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1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708" y="2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Jurgita\Rezident&#363;ra\Mokslas\COST%20registras\Lozana%20STSM\Repository%20(anketos)\Excel%20data%20export\2024%2011%2023%20update\vasculitis_evalandgo_24112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D:\Jurgita\Rezident&#363;ra\Mokslas\COST%20registras\Lozana%20STSM\Repository%20(anketos)\Excel%20data%20export\2024%2011%2023%20update\vasculitis_evalandgo_2411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4AF-445A-A0C2-7472E57E57E2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44AF-445A-A0C2-7472E57E57E2}"/>
              </c:ext>
            </c:extLst>
          </c:dPt>
          <c:dPt>
            <c:idx val="2"/>
            <c:invertIfNegative val="0"/>
            <c:bubble3D val="0"/>
            <c:spPr>
              <a:solidFill>
                <a:srgbClr val="2969A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44AF-445A-A0C2-7472E57E57E2}"/>
              </c:ext>
            </c:extLst>
          </c:dPt>
          <c:dPt>
            <c:idx val="3"/>
            <c:invertIfNegative val="0"/>
            <c:bubble3D val="0"/>
            <c:spPr>
              <a:solidFill>
                <a:srgbClr val="2969A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4AF-445A-A0C2-7472E57E57E2}"/>
              </c:ext>
            </c:extLst>
          </c:dPt>
          <c:dPt>
            <c:idx val="4"/>
            <c:invertIfNegative val="0"/>
            <c:bubble3D val="0"/>
            <c:spPr>
              <a:solidFill>
                <a:srgbClr val="2969A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44AF-445A-A0C2-7472E57E57E2}"/>
              </c:ext>
            </c:extLst>
          </c:dPt>
          <c:dPt>
            <c:idx val="5"/>
            <c:invertIfNegative val="0"/>
            <c:bubble3D val="0"/>
            <c:spPr>
              <a:solidFill>
                <a:srgbClr val="3D7DC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1-44AF-445A-A0C2-7472E57E57E2}"/>
              </c:ext>
            </c:extLst>
          </c:dPt>
          <c:dPt>
            <c:idx val="6"/>
            <c:invertIfNegative val="0"/>
            <c:bubble3D val="0"/>
            <c:spPr>
              <a:solidFill>
                <a:srgbClr val="3D7DC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2-44AF-445A-A0C2-7472E57E57E2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44AF-445A-A0C2-7472E57E57E2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4AF-445A-A0C2-7472E57E57E2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4AF-445A-A0C2-7472E57E57E2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44AF-445A-A0C2-7472E57E57E2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4AF-445A-A0C2-7472E57E57E2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44AF-445A-A0C2-7472E57E57E2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44AF-445A-A0C2-7472E57E57E2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44AF-445A-A0C2-7472E57E57E2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44AF-445A-A0C2-7472E57E57E2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44AF-445A-A0C2-7472E57E57E2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44AF-445A-A0C2-7472E57E57E2}"/>
              </c:ext>
            </c:extLst>
          </c:dPt>
          <c:dPt>
            <c:idx val="18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44AF-445A-A0C2-7472E57E57E2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44AF-445A-A0C2-7472E57E57E2}"/>
              </c:ext>
            </c:extLst>
          </c:dPt>
          <c:dPt>
            <c:idx val="2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2-44AF-445A-A0C2-7472E57E57E2}"/>
              </c:ext>
            </c:extLst>
          </c:dPt>
          <c:dPt>
            <c:idx val="21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44AF-445A-A0C2-7472E57E57E2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4-44AF-445A-A0C2-7472E57E57E2}"/>
              </c:ext>
            </c:extLst>
          </c:dPt>
          <c:dPt>
            <c:idx val="23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44AF-445A-A0C2-7472E57E57E2}"/>
              </c:ext>
            </c:extLst>
          </c:dPt>
          <c:dPt>
            <c:idx val="24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6-44AF-445A-A0C2-7472E57E57E2}"/>
              </c:ext>
            </c:extLst>
          </c:dPt>
          <c:dPt>
            <c:idx val="25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44AF-445A-A0C2-7472E57E57E2}"/>
              </c:ext>
            </c:extLst>
          </c:dPt>
          <c:dPt>
            <c:idx val="26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8-44AF-445A-A0C2-7472E57E57E2}"/>
              </c:ext>
            </c:extLst>
          </c:dPt>
          <c:dPt>
            <c:idx val="27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44AF-445A-A0C2-7472E57E57E2}"/>
              </c:ext>
            </c:extLst>
          </c:dPt>
          <c:dPt>
            <c:idx val="28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A-44AF-445A-A0C2-7472E57E57E2}"/>
              </c:ext>
            </c:extLst>
          </c:dPt>
          <c:dPt>
            <c:idx val="29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44AF-445A-A0C2-7472E57E57E2}"/>
              </c:ext>
            </c:extLst>
          </c:dPt>
          <c:dPt>
            <c:idx val="3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C-44AF-445A-A0C2-7472E57E57E2}"/>
              </c:ext>
            </c:extLst>
          </c:dPt>
          <c:dPt>
            <c:idx val="3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44AF-445A-A0C2-7472E57E57E2}"/>
              </c:ext>
            </c:extLst>
          </c:dPt>
          <c:dPt>
            <c:idx val="32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E-44AF-445A-A0C2-7472E57E57E2}"/>
              </c:ext>
            </c:extLst>
          </c:dPt>
          <c:dPt>
            <c:idx val="33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44AF-445A-A0C2-7472E57E57E2}"/>
              </c:ext>
            </c:extLst>
          </c:dPt>
          <c:dPt>
            <c:idx val="34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0-44AF-445A-A0C2-7472E57E57E2}"/>
              </c:ext>
            </c:extLst>
          </c:dPt>
          <c:dPt>
            <c:idx val="35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1-44AF-445A-A0C2-7472E57E57E2}"/>
              </c:ext>
            </c:extLst>
          </c:dPt>
          <c:dPt>
            <c:idx val="36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2-44AF-445A-A0C2-7472E57E57E2}"/>
              </c:ext>
            </c:extLst>
          </c:dPt>
          <c:dPt>
            <c:idx val="37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3-44AF-445A-A0C2-7472E57E57E2}"/>
              </c:ext>
            </c:extLst>
          </c:dPt>
          <c:dPt>
            <c:idx val="38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4-44AF-445A-A0C2-7472E57E57E2}"/>
              </c:ext>
            </c:extLst>
          </c:dPt>
          <c:dPt>
            <c:idx val="39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5-44AF-445A-A0C2-7472E57E57E2}"/>
              </c:ext>
            </c:extLst>
          </c:dPt>
          <c:dPt>
            <c:idx val="4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6-44AF-445A-A0C2-7472E57E57E2}"/>
              </c:ext>
            </c:extLst>
          </c:dPt>
          <c:dPt>
            <c:idx val="41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7-44AF-445A-A0C2-7472E57E57E2}"/>
              </c:ext>
            </c:extLst>
          </c:dPt>
          <c:dPt>
            <c:idx val="42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8-44AF-445A-A0C2-7472E57E57E2}"/>
              </c:ext>
            </c:extLst>
          </c:dPt>
          <c:dPt>
            <c:idx val="43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9-44AF-445A-A0C2-7472E57E57E2}"/>
              </c:ext>
            </c:extLst>
          </c:dPt>
          <c:dPt>
            <c:idx val="44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A-44AF-445A-A0C2-7472E57E57E2}"/>
              </c:ext>
            </c:extLst>
          </c:dPt>
          <c:dPt>
            <c:idx val="45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B-44AF-445A-A0C2-7472E57E57E2}"/>
              </c:ext>
            </c:extLst>
          </c:dPt>
          <c:dPt>
            <c:idx val="46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C-44AF-445A-A0C2-7472E57E57E2}"/>
              </c:ext>
            </c:extLst>
          </c:dPt>
          <c:dPt>
            <c:idx val="47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D-44AF-445A-A0C2-7472E57E57E2}"/>
              </c:ext>
            </c:extLst>
          </c:dPt>
          <c:dPt>
            <c:idx val="48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E-44AF-445A-A0C2-7472E57E57E2}"/>
              </c:ext>
            </c:extLst>
          </c:dPt>
          <c:dPt>
            <c:idx val="49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2F-44AF-445A-A0C2-7472E57E57E2}"/>
              </c:ext>
            </c:extLst>
          </c:dPt>
          <c:dPt>
            <c:idx val="5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30-44AF-445A-A0C2-7472E57E57E2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19601CC4-CC6C-4F80-994F-777A77D49E1F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12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4AF-445A-A0C2-7472E57E57E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16EC4714-9F39-4F0D-B62C-CFC108C64E77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10.9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44AF-445A-A0C2-7472E57E57E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A9F8662B-7543-4C9C-88D6-211CED0FBF2A}" type="VALUE">
                      <a:rPr lang="en-US" smtClean="0"/>
                      <a:pPr/>
                      <a:t>[VALUE]</a:t>
                    </a:fld>
                    <a:r>
                      <a:rPr lang="en-US"/>
                      <a:t> (7.3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44AF-445A-A0C2-7472E57E57E2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C3184125-28B3-44AA-9E3D-4B6783E18B19}" type="VALUE">
                      <a:rPr lang="en-US" smtClean="0"/>
                      <a:pPr/>
                      <a:t>[VALUE]</a:t>
                    </a:fld>
                    <a:r>
                      <a:rPr lang="en-US"/>
                      <a:t> (6.8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44AF-445A-A0C2-7472E57E57E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441F21DC-A723-47F7-AD1B-1E9487DF516C}" type="VALUE">
                      <a:rPr lang="en-US" smtClean="0"/>
                      <a:pPr/>
                      <a:t>[VALUE]</a:t>
                    </a:fld>
                    <a:r>
                      <a:rPr lang="en-US"/>
                      <a:t> (5.2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44AF-445A-A0C2-7472E57E57E2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EF00A1DA-8906-45CC-9FEE-AAC9D9F1AB29}" type="VALUE">
                      <a:rPr lang="en-US" smtClean="0"/>
                      <a:pPr/>
                      <a:t>[VALUE]</a:t>
                    </a:fld>
                    <a:r>
                      <a:rPr lang="en-US"/>
                      <a:t> (4.7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31-44AF-445A-A0C2-7472E57E57E2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2D614BC4-672E-40E9-8ACF-99AEEFBD1B8F}" type="VALUE">
                      <a:rPr lang="en-US" smtClean="0"/>
                      <a:pPr/>
                      <a:t>[VALUE]</a:t>
                    </a:fld>
                    <a:r>
                      <a:rPr lang="en-US"/>
                      <a:t> (3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32-44AF-445A-A0C2-7472E57E57E2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8D9FFFFB-3306-438D-AB44-5D12E5D2448F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2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44AF-445A-A0C2-7472E57E57E2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991808A4-57DF-45D8-A005-A52E93EA0463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2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44AF-445A-A0C2-7472E57E57E2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fld id="{46C23540-6252-440D-BC04-39C5EF494939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2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44AF-445A-A0C2-7472E57E57E2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fld id="{8B11AA07-8379-4263-BA14-639583E08A17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2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44AF-445A-A0C2-7472E57E57E2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fld id="{E376B672-3FB4-4A18-8778-91C3B869A939}" type="VALUE">
                      <a:rPr lang="en-US" smtClean="0"/>
                      <a:pPr/>
                      <a:t>[VALUE]</a:t>
                    </a:fld>
                    <a:r>
                      <a:rPr lang="en-US"/>
                      <a:t> (2.1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44AF-445A-A0C2-7472E57E57E2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fld id="{F9D7892A-6BBA-4957-A6E3-616D5E3D467C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2.1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44AF-445A-A0C2-7472E57E57E2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fld id="{6564385F-00CA-48F6-97E1-6CC7F56111CE}" type="VALUE">
                      <a:rPr lang="en-US" sz="850" smtClean="0"/>
                      <a:pPr/>
                      <a:t>[VALUE]</a:t>
                    </a:fld>
                    <a:r>
                      <a:rPr lang="en-US" sz="850" dirty="0"/>
                      <a:t> </a:t>
                    </a:r>
                    <a:r>
                      <a:rPr lang="en-US" sz="85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2.1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44AF-445A-A0C2-7472E57E57E2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fld id="{5F1D5A49-F1DC-4F19-9AB8-C1A987DC2E94}" type="VALUE">
                      <a:rPr lang="en-US" sz="850" smtClean="0"/>
                      <a:pPr/>
                      <a:t>[VALUE]</a:t>
                    </a:fld>
                    <a:r>
                      <a:rPr lang="en-US" sz="850" dirty="0"/>
                      <a:t> </a:t>
                    </a:r>
                    <a:r>
                      <a:rPr lang="en-US" sz="85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2.1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C-44AF-445A-A0C2-7472E57E57E2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fld id="{B840591F-C364-47B5-9941-0E50D21FFEE8}" type="VALUE">
                      <a:rPr lang="en-US" sz="850" smtClean="0"/>
                      <a:pPr/>
                      <a:t>[VALUE]</a:t>
                    </a:fld>
                    <a:r>
                      <a:rPr lang="en-US" sz="850" dirty="0"/>
                      <a:t> </a:t>
                    </a:r>
                    <a:r>
                      <a:rPr lang="en-US" sz="85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2.1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44AF-445A-A0C2-7472E57E57E2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fld id="{27396EE9-6A62-49C6-A757-405876453595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1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E-44AF-445A-A0C2-7472E57E57E2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fld id="{93F4DF87-5411-4D7C-A8DD-AAF57497BDEE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44AF-445A-A0C2-7472E57E57E2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fld id="{2BFF90F0-F689-402A-A648-2290FC585019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0-44AF-445A-A0C2-7472E57E57E2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fld id="{345031E7-8ADD-417E-8868-C6E1E3E0A01B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6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44AF-445A-A0C2-7472E57E57E2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fld id="{AC9884A9-6626-44FF-A37C-89D603CE47C1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2-44AF-445A-A0C2-7472E57E57E2}"/>
                </c:ext>
              </c:extLst>
            </c:dLbl>
            <c:dLbl>
              <c:idx val="21"/>
              <c:tx>
                <c:rich>
                  <a:bodyPr/>
                  <a:lstStyle/>
                  <a:p>
                    <a:fld id="{A7701216-A7F8-4108-A23E-5A5DC0B5DD6A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44AF-445A-A0C2-7472E57E57E2}"/>
                </c:ext>
              </c:extLst>
            </c:dLbl>
            <c:dLbl>
              <c:idx val="22"/>
              <c:tx>
                <c:rich>
                  <a:bodyPr/>
                  <a:lstStyle/>
                  <a:p>
                    <a:fld id="{63A79D46-A364-4C37-A423-4433C988B6D1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4-44AF-445A-A0C2-7472E57E57E2}"/>
                </c:ext>
              </c:extLst>
            </c:dLbl>
            <c:dLbl>
              <c:idx val="23"/>
              <c:tx>
                <c:rich>
                  <a:bodyPr/>
                  <a:lstStyle/>
                  <a:p>
                    <a:fld id="{2A7C8D25-4684-4C2F-8721-78B61B9BE4BE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44AF-445A-A0C2-7472E57E57E2}"/>
                </c:ext>
              </c:extLst>
            </c:dLbl>
            <c:dLbl>
              <c:idx val="24"/>
              <c:tx>
                <c:rich>
                  <a:bodyPr/>
                  <a:lstStyle/>
                  <a:p>
                    <a:fld id="{90B4F749-4904-477D-A6B3-7B53D8C28E4E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6-44AF-445A-A0C2-7472E57E57E2}"/>
                </c:ext>
              </c:extLst>
            </c:dLbl>
            <c:dLbl>
              <c:idx val="25"/>
              <c:tx>
                <c:rich>
                  <a:bodyPr/>
                  <a:lstStyle/>
                  <a:p>
                    <a:fld id="{B092A78B-1AC1-4438-A5A7-080DCD038D55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7-44AF-445A-A0C2-7472E57E57E2}"/>
                </c:ext>
              </c:extLst>
            </c:dLbl>
            <c:dLbl>
              <c:idx val="26"/>
              <c:tx>
                <c:rich>
                  <a:bodyPr/>
                  <a:lstStyle/>
                  <a:p>
                    <a:fld id="{03C000B8-8E91-4BC7-9596-226706C1100E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8-44AF-445A-A0C2-7472E57E57E2}"/>
                </c:ext>
              </c:extLst>
            </c:dLbl>
            <c:dLbl>
              <c:idx val="27"/>
              <c:tx>
                <c:rich>
                  <a:bodyPr/>
                  <a:lstStyle/>
                  <a:p>
                    <a:fld id="{8164D54B-B246-4729-9914-C7D8EAEA77E2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9-44AF-445A-A0C2-7472E57E57E2}"/>
                </c:ext>
              </c:extLst>
            </c:dLbl>
            <c:dLbl>
              <c:idx val="28"/>
              <c:tx>
                <c:rich>
                  <a:bodyPr/>
                  <a:lstStyle/>
                  <a:p>
                    <a:fld id="{BB0ACCF5-FF36-40B4-A1CD-8AF7B17E47B9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A-44AF-445A-A0C2-7472E57E57E2}"/>
                </c:ext>
              </c:extLst>
            </c:dLbl>
            <c:dLbl>
              <c:idx val="29"/>
              <c:tx>
                <c:rich>
                  <a:bodyPr/>
                  <a:lstStyle/>
                  <a:p>
                    <a:fld id="{996D0315-6382-4930-B2D0-E475DB5AB36B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B-44AF-445A-A0C2-7472E57E57E2}"/>
                </c:ext>
              </c:extLst>
            </c:dLbl>
            <c:dLbl>
              <c:idx val="30"/>
              <c:tx>
                <c:rich>
                  <a:bodyPr/>
                  <a:lstStyle/>
                  <a:p>
                    <a:fld id="{51DD9570-E951-4D7C-861C-F83B8AE3EB65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1.0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C-44AF-445A-A0C2-7472E57E57E2}"/>
                </c:ext>
              </c:extLst>
            </c:dLbl>
            <c:dLbl>
              <c:idx val="31"/>
              <c:tx>
                <c:rich>
                  <a:bodyPr/>
                  <a:lstStyle/>
                  <a:p>
                    <a:fld id="{39AB4505-1A63-4A92-B980-2753A00F2464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D-44AF-445A-A0C2-7472E57E57E2}"/>
                </c:ext>
              </c:extLst>
            </c:dLbl>
            <c:dLbl>
              <c:idx val="32"/>
              <c:tx>
                <c:rich>
                  <a:bodyPr/>
                  <a:lstStyle/>
                  <a:p>
                    <a:fld id="{F39F9D14-23DB-48FC-99B9-42F70EB7759D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E-44AF-445A-A0C2-7472E57E57E2}"/>
                </c:ext>
              </c:extLst>
            </c:dLbl>
            <c:dLbl>
              <c:idx val="33"/>
              <c:tx>
                <c:rich>
                  <a:bodyPr/>
                  <a:lstStyle/>
                  <a:p>
                    <a:fld id="{03752A47-2BC9-4BC3-8655-E3F1577124F8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F-44AF-445A-A0C2-7472E57E57E2}"/>
                </c:ext>
              </c:extLst>
            </c:dLbl>
            <c:dLbl>
              <c:idx val="34"/>
              <c:tx>
                <c:rich>
                  <a:bodyPr/>
                  <a:lstStyle/>
                  <a:p>
                    <a:fld id="{85EF0875-EE75-4064-A98A-75F17A47B472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0-44AF-445A-A0C2-7472E57E57E2}"/>
                </c:ext>
              </c:extLst>
            </c:dLbl>
            <c:dLbl>
              <c:idx val="35"/>
              <c:tx>
                <c:rich>
                  <a:bodyPr/>
                  <a:lstStyle/>
                  <a:p>
                    <a:fld id="{5E545AA4-2941-4CF7-A265-64D8AF00D459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1-44AF-445A-A0C2-7472E57E57E2}"/>
                </c:ext>
              </c:extLst>
            </c:dLbl>
            <c:dLbl>
              <c:idx val="36"/>
              <c:tx>
                <c:rich>
                  <a:bodyPr/>
                  <a:lstStyle/>
                  <a:p>
                    <a:fld id="{7758BFBF-7152-4D12-9BF2-5FCA254FA334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2-44AF-445A-A0C2-7472E57E57E2}"/>
                </c:ext>
              </c:extLst>
            </c:dLbl>
            <c:dLbl>
              <c:idx val="37"/>
              <c:tx>
                <c:rich>
                  <a:bodyPr/>
                  <a:lstStyle/>
                  <a:p>
                    <a:fld id="{AD949174-71E6-4757-B6E9-63B50694E817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3-44AF-445A-A0C2-7472E57E57E2}"/>
                </c:ext>
              </c:extLst>
            </c:dLbl>
            <c:dLbl>
              <c:idx val="38"/>
              <c:tx>
                <c:rich>
                  <a:bodyPr/>
                  <a:lstStyle/>
                  <a:p>
                    <a:fld id="{FDBDF036-3034-42AD-9CE7-198A41FC8B3F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4-44AF-445A-A0C2-7472E57E57E2}"/>
                </c:ext>
              </c:extLst>
            </c:dLbl>
            <c:dLbl>
              <c:idx val="39"/>
              <c:tx>
                <c:rich>
                  <a:bodyPr/>
                  <a:lstStyle/>
                  <a:p>
                    <a:fld id="{6B0ECFDB-BE9B-4FCA-A3D3-252BEF84D91B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5-44AF-445A-A0C2-7472E57E57E2}"/>
                </c:ext>
              </c:extLst>
            </c:dLbl>
            <c:dLbl>
              <c:idx val="40"/>
              <c:tx>
                <c:rich>
                  <a:bodyPr/>
                  <a:lstStyle/>
                  <a:p>
                    <a:fld id="{45FA045E-3DC9-434A-B590-8307DBE0684F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6-44AF-445A-A0C2-7472E57E57E2}"/>
                </c:ext>
              </c:extLst>
            </c:dLbl>
            <c:dLbl>
              <c:idx val="41"/>
              <c:tx>
                <c:rich>
                  <a:bodyPr/>
                  <a:lstStyle/>
                  <a:p>
                    <a:fld id="{771DF728-69F7-4F49-9E66-4B6A9E9457E4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7-44AF-445A-A0C2-7472E57E57E2}"/>
                </c:ext>
              </c:extLst>
            </c:dLbl>
            <c:dLbl>
              <c:idx val="42"/>
              <c:tx>
                <c:rich>
                  <a:bodyPr/>
                  <a:lstStyle/>
                  <a:p>
                    <a:fld id="{635ACC5C-6E24-4187-9BB3-B4E7B5B4FD18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8-44AF-445A-A0C2-7472E57E57E2}"/>
                </c:ext>
              </c:extLst>
            </c:dLbl>
            <c:dLbl>
              <c:idx val="43"/>
              <c:tx>
                <c:rich>
                  <a:bodyPr/>
                  <a:lstStyle/>
                  <a:p>
                    <a:fld id="{C5139EDC-DCFA-41C8-AFD6-AF792BC9382E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9-44AF-445A-A0C2-7472E57E57E2}"/>
                </c:ext>
              </c:extLst>
            </c:dLbl>
            <c:dLbl>
              <c:idx val="44"/>
              <c:tx>
                <c:rich>
                  <a:bodyPr/>
                  <a:lstStyle/>
                  <a:p>
                    <a:fld id="{2CE7C5F3-2AD7-4698-8B7D-94C2137AF127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A-44AF-445A-A0C2-7472E57E57E2}"/>
                </c:ext>
              </c:extLst>
            </c:dLbl>
            <c:dLbl>
              <c:idx val="45"/>
              <c:tx>
                <c:rich>
                  <a:bodyPr/>
                  <a:lstStyle/>
                  <a:p>
                    <a:fld id="{348BEF09-5F35-448A-8B29-F6CABB5DB05C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B-44AF-445A-A0C2-7472E57E57E2}"/>
                </c:ext>
              </c:extLst>
            </c:dLbl>
            <c:dLbl>
              <c:idx val="46"/>
              <c:tx>
                <c:rich>
                  <a:bodyPr/>
                  <a:lstStyle/>
                  <a:p>
                    <a:fld id="{1BEE7BC0-2B38-4BEB-ABC6-92D1F0F07296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C-44AF-445A-A0C2-7472E57E57E2}"/>
                </c:ext>
              </c:extLst>
            </c:dLbl>
            <c:dLbl>
              <c:idx val="47"/>
              <c:tx>
                <c:rich>
                  <a:bodyPr/>
                  <a:lstStyle/>
                  <a:p>
                    <a:fld id="{CC61F214-6BA9-4D53-B8B6-49DC4558CDAB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D-44AF-445A-A0C2-7472E57E57E2}"/>
                </c:ext>
              </c:extLst>
            </c:dLbl>
            <c:dLbl>
              <c:idx val="48"/>
              <c:tx>
                <c:rich>
                  <a:bodyPr/>
                  <a:lstStyle/>
                  <a:p>
                    <a:fld id="{65EB60C9-5510-4EF3-9724-48D7A2EDFCA3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E-44AF-445A-A0C2-7472E57E57E2}"/>
                </c:ext>
              </c:extLst>
            </c:dLbl>
            <c:dLbl>
              <c:idx val="49"/>
              <c:tx>
                <c:rich>
                  <a:bodyPr/>
                  <a:lstStyle/>
                  <a:p>
                    <a:fld id="{B30128CA-2569-47B4-85DC-E27E48516FB0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2F-44AF-445A-A0C2-7472E57E57E2}"/>
                </c:ext>
              </c:extLst>
            </c:dLbl>
            <c:dLbl>
              <c:idx val="50"/>
              <c:tx>
                <c:rich>
                  <a:bodyPr/>
                  <a:lstStyle/>
                  <a:p>
                    <a:fld id="{9ADFA7D4-D559-465E-AD0D-08604C660D66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 </a:t>
                    </a:r>
                    <a:r>
                      <a:rPr lang="en-US" sz="800" b="0" i="0" u="none" strike="noStrike" kern="1200" baseline="0" dirty="0">
                        <a:solidFill>
                          <a:prstClr val="black">
                            <a:lumMod val="75000"/>
                            <a:lumOff val="25000"/>
                          </a:prstClr>
                        </a:solidFill>
                      </a:rPr>
                      <a:t>(0.5%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30-44AF-445A-A0C2-7472E57E57E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85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[vasculitis_evalandgo_241123.xlsx]Q11 by country'!$A$159:$A$209</c:f>
              <c:strCache>
                <c:ptCount val="51"/>
                <c:pt idx="0">
                  <c:v>France</c:v>
                </c:pt>
                <c:pt idx="1">
                  <c:v>Turkey</c:v>
                </c:pt>
                <c:pt idx="2">
                  <c:v>Brazil</c:v>
                </c:pt>
                <c:pt idx="3">
                  <c:v>Spain</c:v>
                </c:pt>
                <c:pt idx="4">
                  <c:v>Germany</c:v>
                </c:pt>
                <c:pt idx="5">
                  <c:v>Switzerland</c:v>
                </c:pt>
                <c:pt idx="6">
                  <c:v>Croatia</c:v>
                </c:pt>
                <c:pt idx="7">
                  <c:v>India</c:v>
                </c:pt>
                <c:pt idx="8">
                  <c:v>New Zealand</c:v>
                </c:pt>
                <c:pt idx="9">
                  <c:v>Portugal</c:v>
                </c:pt>
                <c:pt idx="10">
                  <c:v>United Kingdom</c:v>
                </c:pt>
                <c:pt idx="11">
                  <c:v>Egypt</c:v>
                </c:pt>
                <c:pt idx="12">
                  <c:v>Israel</c:v>
                </c:pt>
                <c:pt idx="13">
                  <c:v>Libyan Arab Jamahiriya</c:v>
                </c:pt>
                <c:pt idx="14">
                  <c:v>Lithuania</c:v>
                </c:pt>
                <c:pt idx="15">
                  <c:v>Ukraine</c:v>
                </c:pt>
                <c:pt idx="16">
                  <c:v>Bulgaria</c:v>
                </c:pt>
                <c:pt idx="17">
                  <c:v>Italy</c:v>
                </c:pt>
                <c:pt idx="18">
                  <c:v>Mexico</c:v>
                </c:pt>
                <c:pt idx="19">
                  <c:v>Poland</c:v>
                </c:pt>
                <c:pt idx="20">
                  <c:v>Algeria</c:v>
                </c:pt>
                <c:pt idx="21">
                  <c:v>Colombia</c:v>
                </c:pt>
                <c:pt idx="22">
                  <c:v>Estonia</c:v>
                </c:pt>
                <c:pt idx="23">
                  <c:v>Ghana</c:v>
                </c:pt>
                <c:pt idx="24">
                  <c:v>Greece</c:v>
                </c:pt>
                <c:pt idx="25">
                  <c:v>Indonesia</c:v>
                </c:pt>
                <c:pt idx="26">
                  <c:v>Morocco</c:v>
                </c:pt>
                <c:pt idx="27">
                  <c:v>Netherlands</c:v>
                </c:pt>
                <c:pt idx="28">
                  <c:v>Slovenia</c:v>
                </c:pt>
                <c:pt idx="29">
                  <c:v>Tunisia</c:v>
                </c:pt>
                <c:pt idx="30">
                  <c:v>United States</c:v>
                </c:pt>
                <c:pt idx="31">
                  <c:v>Argentina</c:v>
                </c:pt>
                <c:pt idx="32">
                  <c:v>Armenia</c:v>
                </c:pt>
                <c:pt idx="33">
                  <c:v>Austria</c:v>
                </c:pt>
                <c:pt idx="34">
                  <c:v>Bangladesh</c:v>
                </c:pt>
                <c:pt idx="35">
                  <c:v>Canada</c:v>
                </c:pt>
                <c:pt idx="36">
                  <c:v>Czech Republic</c:v>
                </c:pt>
                <c:pt idx="37">
                  <c:v>Georgia</c:v>
                </c:pt>
                <c:pt idx="38">
                  <c:v>Guadeloupe</c:v>
                </c:pt>
                <c:pt idx="39">
                  <c:v>Hong Kong</c:v>
                </c:pt>
                <c:pt idx="40">
                  <c:v>Ireland</c:v>
                </c:pt>
                <c:pt idx="41">
                  <c:v>Kenya</c:v>
                </c:pt>
                <c:pt idx="42">
                  <c:v>Macedonia</c:v>
                </c:pt>
                <c:pt idx="43">
                  <c:v>Moldova, Republic of</c:v>
                </c:pt>
                <c:pt idx="44">
                  <c:v>Monaco</c:v>
                </c:pt>
                <c:pt idx="45">
                  <c:v>Saudi Arabia</c:v>
                </c:pt>
                <c:pt idx="46">
                  <c:v>Serbia and Montenegro</c:v>
                </c:pt>
                <c:pt idx="47">
                  <c:v>Singapore</c:v>
                </c:pt>
                <c:pt idx="48">
                  <c:v>Slovakia</c:v>
                </c:pt>
                <c:pt idx="49">
                  <c:v>Sweden</c:v>
                </c:pt>
                <c:pt idx="50">
                  <c:v>Uruguay</c:v>
                </c:pt>
              </c:strCache>
            </c:strRef>
          </c:cat>
          <c:val>
            <c:numRef>
              <c:f>'[vasculitis_evalandgo_241123.xlsx]Q11 by country'!$B$159:$B$209</c:f>
              <c:numCache>
                <c:formatCode>General</c:formatCode>
                <c:ptCount val="51"/>
                <c:pt idx="0">
                  <c:v>24</c:v>
                </c:pt>
                <c:pt idx="1">
                  <c:v>21</c:v>
                </c:pt>
                <c:pt idx="2">
                  <c:v>14</c:v>
                </c:pt>
                <c:pt idx="3">
                  <c:v>13</c:v>
                </c:pt>
                <c:pt idx="4">
                  <c:v>10</c:v>
                </c:pt>
                <c:pt idx="5">
                  <c:v>9</c:v>
                </c:pt>
                <c:pt idx="6">
                  <c:v>7</c:v>
                </c:pt>
                <c:pt idx="7">
                  <c:v>5</c:v>
                </c:pt>
                <c:pt idx="8">
                  <c:v>5</c:v>
                </c:pt>
                <c:pt idx="9">
                  <c:v>5</c:v>
                </c:pt>
                <c:pt idx="10">
                  <c:v>5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4</c:v>
                </c:pt>
                <c:pt idx="16">
                  <c:v>3</c:v>
                </c:pt>
                <c:pt idx="17">
                  <c:v>3</c:v>
                </c:pt>
                <c:pt idx="18">
                  <c:v>3</c:v>
                </c:pt>
                <c:pt idx="19">
                  <c:v>3</c:v>
                </c:pt>
                <c:pt idx="20">
                  <c:v>2</c:v>
                </c:pt>
                <c:pt idx="21">
                  <c:v>2</c:v>
                </c:pt>
                <c:pt idx="22">
                  <c:v>2</c:v>
                </c:pt>
                <c:pt idx="23">
                  <c:v>2</c:v>
                </c:pt>
                <c:pt idx="24">
                  <c:v>2</c:v>
                </c:pt>
                <c:pt idx="25">
                  <c:v>2</c:v>
                </c:pt>
                <c:pt idx="26">
                  <c:v>2</c:v>
                </c:pt>
                <c:pt idx="27">
                  <c:v>2</c:v>
                </c:pt>
                <c:pt idx="28">
                  <c:v>2</c:v>
                </c:pt>
                <c:pt idx="29">
                  <c:v>2</c:v>
                </c:pt>
                <c:pt idx="30">
                  <c:v>2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02-4A3B-82B5-F74A0E5BBA4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1594096607"/>
        <c:axId val="1594099967"/>
      </c:barChart>
      <c:catAx>
        <c:axId val="1594096607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4099967"/>
        <c:crosses val="autoZero"/>
        <c:auto val="1"/>
        <c:lblAlgn val="ctr"/>
        <c:lblOffset val="100"/>
        <c:noMultiLvlLbl val="0"/>
      </c:catAx>
      <c:valAx>
        <c:axId val="1594099967"/>
        <c:scaling>
          <c:orientation val="minMax"/>
        </c:scaling>
        <c:delete val="1"/>
        <c:axPos val="t"/>
        <c:numFmt formatCode="General" sourceLinked="1"/>
        <c:majorTickMark val="none"/>
        <c:minorTickMark val="none"/>
        <c:tickLblPos val="nextTo"/>
        <c:crossAx val="15940966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50"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'Q11 by country'!$A$159:$A$209</cx:f>
        <cx:nf>'Q11 by country'!$A$158</cx:nf>
        <cx:lvl ptCount="51" name="Row Labels">
          <cx:pt idx="0">France</cx:pt>
          <cx:pt idx="1">Turkey</cx:pt>
          <cx:pt idx="2">Brazil</cx:pt>
          <cx:pt idx="3">Spain</cx:pt>
          <cx:pt idx="4">Germany</cx:pt>
          <cx:pt idx="5">Switzerland</cx:pt>
          <cx:pt idx="6">Croatia</cx:pt>
          <cx:pt idx="7">India</cx:pt>
          <cx:pt idx="8">New Zealand</cx:pt>
          <cx:pt idx="9">Portugal</cx:pt>
          <cx:pt idx="10">United Kingdom</cx:pt>
          <cx:pt idx="11">Egypt</cx:pt>
          <cx:pt idx="12">Israel</cx:pt>
          <cx:pt idx="13">Libyan Arab Jamahiriya</cx:pt>
          <cx:pt idx="14">Lithuania</cx:pt>
          <cx:pt idx="15">Ukraine</cx:pt>
          <cx:pt idx="16">Bulgaria</cx:pt>
          <cx:pt idx="17">Italy</cx:pt>
          <cx:pt idx="18">Mexico</cx:pt>
          <cx:pt idx="19">Poland</cx:pt>
          <cx:pt idx="20">Algeria</cx:pt>
          <cx:pt idx="21">Colombia</cx:pt>
          <cx:pt idx="22">Estonia</cx:pt>
          <cx:pt idx="23">Ghana</cx:pt>
          <cx:pt idx="24">Greece</cx:pt>
          <cx:pt idx="25">Indonesia</cx:pt>
          <cx:pt idx="26">Morocco</cx:pt>
          <cx:pt idx="27">Netherlands</cx:pt>
          <cx:pt idx="28">Slovenia</cx:pt>
          <cx:pt idx="29">Tunisia</cx:pt>
          <cx:pt idx="30">United States</cx:pt>
          <cx:pt idx="31">Argentina</cx:pt>
          <cx:pt idx="32">Armenia</cx:pt>
          <cx:pt idx="33">Austria</cx:pt>
          <cx:pt idx="34">Bangladesh</cx:pt>
          <cx:pt idx="35">Canada</cx:pt>
          <cx:pt idx="36">Czech Republic</cx:pt>
          <cx:pt idx="37">Georgia</cx:pt>
          <cx:pt idx="38">Guadeloupe</cx:pt>
          <cx:pt idx="39">Hong Kong</cx:pt>
          <cx:pt idx="40">Ireland</cx:pt>
          <cx:pt idx="41">Kenya</cx:pt>
          <cx:pt idx="42">Macedonia, The Former Yugoslav Republic of</cx:pt>
          <cx:pt idx="43">Moldova, Republic of</cx:pt>
          <cx:pt idx="44">Monaco</cx:pt>
          <cx:pt idx="45">Saudi Arabia</cx:pt>
          <cx:pt idx="46">Serbia and Montenegro</cx:pt>
          <cx:pt idx="47">Singapore</cx:pt>
          <cx:pt idx="48">Slovakia</cx:pt>
          <cx:pt idx="49">Sweden</cx:pt>
          <cx:pt idx="50">Uruguay</cx:pt>
        </cx:lvl>
      </cx:strDim>
      <cx:numDim type="colorVal">
        <cx:f>'Q11 by country'!$B$159:$B$209</cx:f>
        <cx:lvl ptCount="51" formatCode="General">
          <cx:pt idx="0">24</cx:pt>
          <cx:pt idx="1">21</cx:pt>
          <cx:pt idx="2">14</cx:pt>
          <cx:pt idx="3">13</cx:pt>
          <cx:pt idx="4">10</cx:pt>
          <cx:pt idx="5">9</cx:pt>
          <cx:pt idx="6">7</cx:pt>
          <cx:pt idx="7">5</cx:pt>
          <cx:pt idx="8">5</cx:pt>
          <cx:pt idx="9">5</cx:pt>
          <cx:pt idx="10">5</cx:pt>
          <cx:pt idx="11">4</cx:pt>
          <cx:pt idx="12">4</cx:pt>
          <cx:pt idx="13">4</cx:pt>
          <cx:pt idx="14">4</cx:pt>
          <cx:pt idx="15">4</cx:pt>
          <cx:pt idx="16">3</cx:pt>
          <cx:pt idx="17">3</cx:pt>
          <cx:pt idx="18">3</cx:pt>
          <cx:pt idx="19">3</cx:pt>
          <cx:pt idx="20">2</cx:pt>
          <cx:pt idx="21">2</cx:pt>
          <cx:pt idx="22">2</cx:pt>
          <cx:pt idx="23">2</cx:pt>
          <cx:pt idx="24">2</cx:pt>
          <cx:pt idx="25">2</cx:pt>
          <cx:pt idx="26">2</cx:pt>
          <cx:pt idx="27">2</cx:pt>
          <cx:pt idx="28">2</cx:pt>
          <cx:pt idx="29">2</cx:pt>
          <cx:pt idx="30">2</cx:pt>
          <cx:pt idx="31">1</cx:pt>
          <cx:pt idx="32">1</cx:pt>
          <cx:pt idx="33">1</cx:pt>
          <cx:pt idx="34">1</cx:pt>
          <cx:pt idx="35">1</cx:pt>
          <cx:pt idx="36">1</cx:pt>
          <cx:pt idx="37">1</cx:pt>
          <cx:pt idx="38">1</cx:pt>
          <cx:pt idx="39">1</cx:pt>
          <cx:pt idx="40">1</cx:pt>
          <cx:pt idx="41">1</cx:pt>
          <cx:pt idx="42">1</cx:pt>
          <cx:pt idx="43">1</cx:pt>
          <cx:pt idx="44">1</cx:pt>
          <cx:pt idx="45">1</cx:pt>
          <cx:pt idx="46">1</cx:pt>
          <cx:pt idx="47">1</cx:pt>
          <cx:pt idx="48">1</cx:pt>
          <cx:pt idx="49">1</cx:pt>
          <cx:pt idx="50">1</cx:pt>
        </cx:lvl>
      </cx:numDim>
    </cx:data>
  </cx:chartData>
  <cx:chart>
    <cx:plotArea>
      <cx:plotAreaRegion>
        <cx:series layoutId="regionMap" uniqueId="{594A56C0-4C1F-445E-8C9C-D43776413A29}">
          <cx:dataId val="0"/>
          <cx:layoutPr>
            <cx:regionLabelLayout val="none"/>
            <cx:geography viewedRegionType="world" cultureLanguage="en-US" cultureRegion="LT" attribution="Powered by Bing">
              <cx:geoCache provider="{E9337A44-BEBE-4D9F-B70C-5C5E7DAFC167}">
                <cx:binary>7H3ZcuS40e6rdMy1qSGI3eFxxJCsRbtaSy9zwyhJ1dwB7tuz/XfnxU5SUqmrOOWW5oz+aEUclx1t
CxCKyS+BXD4koH/ddf+8S9ar4kOXJqr851332y9BVWX//PXX8i5Yp6vyIA3vCl3qb9XBnU5/1d++
hXfrX++LVRsq/1fLROTXu2BVVOvul3//C77NX+sTfbeqQq0+1uuiv1yXdVKVP+jb2/XhTteqGof7
8E2//fJ74q+LcPXLh7Wqwqq/7rP1b7/s/M4vH36dftOfnvohAcGq+h7GWuLAhI/FmHz6/PIh0crf
dB+MrcJi4y+NH7R59NkqheGvkOdBmtX9fbEuyw9P/7s1cEf4rfaw1M7juzt6FNT94+HNft3F9t//
mjTAu05atuCfAvNS1xT967qI1/0Ggb8PPhYHUkiTECSf0d0CH9MDgrGFheTPunnU+yP41//nf4o4
7Nc/Emg/+t9HTuD/3jHF//ry5+O/hIn54Rj++dEb/8X5bx0QCyGY4XifChAiB4gxU0pKNw99BP9Z
lg9XvwM0/3k97tfAZPhEDZPeqS6Wxz9fFxe6qGp/lfzo1f+aKrA8YMJCklO+Y4MMfiChQ3CJn5YB
9G+vg9eIsl8L30dOFPC9Y4r9xfXPx35erNTdD5f9X0OesANmEWFKaxd5WBtUYM4A+r0G6GU59sO+
GTcBfdM8hXz+DkyPM6zvgg+X66y+TcK7zfz7+y6AyANOMPgAhB7tD96Z+4geYCyQydCTB5743wex
fhwP7FfB88CJDp7bp0pw3oH/tYvVEL6hxTGQCfCOH9Pagd2g+MB60Ad/wh36t03Oy5Lsh30zboL6
pnkKuv0OZv6huv/xBPtrtsayDjC1qCnoxprvIM/lAWaYcS7F43pgu8C/KM1+3J+GTWB/ap2ifnj2
8038VbYK1ebV38DMwESX5mhjHqf1dL7jA0oJZmxjhaZx/ovi7If9adgE9qfWKeyzq58P+2KtC/8t
pztBENSYgoF/3ZnnhByYENIIJMSjaxUbZT+Gl68QZD/kzwMnoD+3T2FfzH4+7M5Kre7fMKtl1gHl
WApm0kcrMjHvEgIeE9yqoN+Xw7Z5f1me/eBvxk2w3zRPoXd+//nQL9ZFulJvmNRSdGBKJAV4zseZ
vRtTji4XFoTJxZOBn0Q0r5BnP/bPAyfgP7dP0XffwcQ/1Wp1pzdL/w3sPD7gwBhIhL/Hi1uMAj8g
iEtqoqdlMbqB7Xn/sjj7sd+Mm0C/aZ4if+r8/Hl/1YbVsC6SlbrfYPAG8LMDYSLA39wbzYsDC5uS
EUaf0qlJIvtKmfbrYGfwRBE7fVNtOMufr42buIB45y1TWnlABAcyYZO77lohjA4sjgSGhbDX/b5C
nv1aeB440cBz+xT9m3fgA5xCAyH8hv6XQNrKqCCEW08zfSf4gayWUU4tZNHN2nuMel4hyH7YnwdO
YH9un8K+fAeZ1aJYr9+SxhnpZEkxExKSpi2rbyGgmTlHlniyO9NY80U59oO+kX+C+aZ5CvniHUB+
tm4//LFeva3VNyDIHx2qwPJ7OLmFP+LWgcDA8iM28bevFGc//DuDJzrY6Zsq4uwdUDnHa9W/ocFB
B+MmChMYAN5CHlYEwQiDy31iMCcO90Up9iP/NGyC+VPrFO3jdxBmnoRVUK/UW5p4CiaegHEXhD+m
WLvEpQWB6MS4v0qI/YBvDZ2AvtUzBf7kHTD1Nyqs1vcfjmGT+F6nG2f39wNN4CclwTDdNyQamPSt
eW9A/ktNysgm/50G+q+Xa79CpuMnWpl2T1WzsH9+yHmh39YLUOvAQlRiwvdyDkgeIPABFmQAj59J
3vuyOPs1sRk30cCmeYr8xcnPR37m91n1dmvBYuB9Ldi/2nD1gOzWWrDkgeDgezd8w3QpvCjNftyf
hk1gf2qdoj5b/HzU7TrxV29aO0IsYNFGmk3KXcShbkHQkfKckPevEWE/2t9HTgD/3jHF3H4HmB+W
xWr9hhtW2DwQyCIW3XBru2YfkwMI8Ql/YtZME3zyNr3zsjj70d+Mm2C/aZ4if/gObMxNUfv16g1p
TQNDEM8ppRBP7sx2gzKg8oFSw+YYD40h0S7qrxBlP+zPAye4P7dPgb/5+vPNzEl426/Uh9+L1e2H
o1W6CsIifMtIH6y9sMCRMusp7tyN+JE4AP6NcYt8L6naXgIP4m30sy8O26+Kp2ETRTy1TtVw8g7U
8Hvhj6+t3jDHMsC8SEilJGycPE70XU7NYNAPyAu6KVaYmJ9XybQf/62hEx1s9Uz1MNZlQTHkpB7w
Tw3/qyWDh9UqeUMrRGCj1gIjZAryHEVuxTrIgmq1sWPjASZB5ovS7Ef/adgE+afWKeqH7yDtWgSw
ofijVf7XahagRhaidkvgTbZFdj0A7HgB4GCQHpcF/Lt59tNm7kvi7If96S0msD+1TmFfLH/+ZD9d
d+Fb7mYBiSAxhpxqpBK2pjnU7UCCCzsp4392oX5ZhP1Yb8ZNwN40T9E+/fLz0XZ0otPbt+R0oCYB
5i5ichLhAH8pTSEgf32yKxPQXyPJfti/j5wA/71jCr1z/vOhn5WVfls2TQBdZkGpJUT2D5/dqMYa
ywChSJxbmzL93Vn/Cnn24/88cAL/c/sU/dk7YDNPdXKvm9U/nssxP+hvGzz2hXR/zdgTDqV/loW+
W/Md2wMHJmD/FlIr+RR/Tlzsk3A/kme/Kp4HTlTx3D5Vxan78xfC73VZvS2nwA+o4CY3yW5wOdbh
E1MKgZ/YtQnsrxBkP+zPAyewP7dPYf/9HcQ3ULio1bp8S9tvmAdoPOWwoSfBCgHEW053PAphgs+l
4Ag2s/sxvHmVNPvR3xo6wX+rZ6qBw/cw8Yt0/aYegJgHHKIZOIgFahg/u/Mf6gUZhwJNWAOPDuJP
udWL8uzXwO+bF5ng/9w+Rf/3059vds7WVfBYu1NupuLfN/wjgU8ow2D6dyY+FCuA2zVhB/1RMdPo
/pXC7Id/Z/BEBTt9UzWcvQOS7VQX+u4tA34oy4HNcjgEBO718bOjCTgJhPF4UmXTOy6SbXbnFQLt
V8PzwIkKntun8J/+/vNXwVWimzc2QuwAgfkhz25gNxEADyCA54TP/jD0NQLtx//7yIkCvndMNXB1
+PM18LTPeVWtqvUbWiI4CUdNTOFg0N69dUPKAxOK1xiWT4wz8BHby+DVYu1XxmT4RCOT3qlabq5+
vlquaxW+aXCE8YGAU1oEdrt2DBIUGUKYhPmTTzbNiT16hSD7VfA8cAL+c/sU9ut3cGZlcmr1cUb+
fb8MJ4b+e0R3cpHAw6zxJ3cMTI+rX0HVySrTxXpjHf6+LhAc3oJo6Nn/TnZ+wW9DAbSwTALbBA+f
zaMfM4VXSbR/RWwNnayJrZ7pqrha/HxjZK+Un6zu12WwweLvqwGIUahpgFry/YfopHkAW8QWF+PW
/PiZ7Ei+TqT9etgeO1HEdtdUE/Y7yNkWNagh0XX2lguCAdSWELt8ncGgIpQJqEdk3ytCtz3060TZ
r4HtsRMNbHdNNbC4+Plr4bBYv3nRlWAUKj83ZVUTPcDVARzCWbkpDZqea3yFQPuV8DxwooHn9in8
h++BOF3drYE4CoE6vQ7WH+Yacv/iw9fa12Wyav4KnTrZU33pIpXH228ekHzJaT3TnW8VPox8LhwC
AV59b10e8LmUAddLJjbyFXLsnxnPAycz47l9OjPeA4/7/d6Xt4L9v3fbPN/69Kp5f7Wq78OHspm3
ZHUtoM0tZgnEIUXcInOBTqREIImAaX/4TCjd10qzfwnsjp6sg93O6WK4eg+8yrqAbdUPcDLwA5xg
rNZq7RcvntH837OIIwWyit9yVhDYbYSKWIr5rruEGmUCwQzcv7C/eOo1kvyHGfH8DtPZ8Nzxp5nw
Di45umrX9+s3vIaBwhVHnEgOIeNzYL61KoFfgwPpAjbANgdENynDU/r0ojj/Af2ncVPsn5r/hPw7
CFWe76F5K3/034t2/kIQ9mKV5F/bUv//pmbzPzuB5zsY3VW1mj1c3rgVNP+4dxM/TIY+Ub572YTH
VXN4/9sviEOxzvOVkONX7FDFO3tMk1HrVVn99guEz9Z49RrcpTEeIZUmfF+7HnswHPKFYsTxThnY
MxMPV+QpuBYu+O0XOJ80VimaMJBQbmIEjqbU9UMXbHQCbWHBHQVw+wlUd5HnGzPh0Erva/WMxtPP
H1SdXuhQVSXcVwlflD3+2vh2EL1IqAWG+H68oxK+zoTSu+xudQnUF/w2+gcSQ9n1cSHtMsuN676k
Vm1XldnHduvlpcvjiik7JmU1K3kQLCJiRunM4EVn09bCtmV29SyIWutIME9+HaJOfc67LmkdWhki
mQ8qiJntZ9K7JrguDmVmNo7qeT/fQn3Pe4xiTl4DrlqjkKmC+8WWZe6+hkl6kWNRCFtEA55nuKlq
2/RJaWO/8twySfNL3ZFg2RoyPjQH03R+/Hw8PuBPAgi4CJRCHRKQFhAvbuPYk1ynRdsLu/SS6KSI
zPi0akMW21VeRbbn4TqwS7/xjrJYGEtex70b+MZVwvzyUGX9rBkK7mA5LEHK8nxo4vzckl25aItc
LjJRFofjCVky06WK7EBlxo00seGEhMmvUV0O5JQUKGJOz+NhTtvKO3qEOh2aF1513M6dviqTsMsI
ZYUEE9jz3X1V5XOz4XHu2XUYZ5dxGcmzsjNpOR+GTLJ5oIfurBUyYnbcCdE4ddZVqRMTDzuJkMFn
2bTJihceK2yzw7JM7dhvE8v2aU0Nt40imHE/1g4yR5l21QN00liaR4UF65DCItxWT4tJk6BKYbuq
8+QMoW5dxdkwM+AFZ9KKm+NUt95RJbsrqyPDkqetaVd+RW/7tEnPG9ypxNVKpy7qgnzhFTzJzsJY
1sckRu3NEITizi+zvprpAer5nb5I8xsyKMNOItke9SGu55gp80L0eh55iixAjfncSCvmqqzEiy6M
89u4q4pTJHHxObZw/01jaVzmKE2OeCjruedl1llmlIZDNDFmvOliBxVxeZx1JT8XvRIzXbfqitNG
3mtvuCliMXzSda4+60CpTwZPmFsjHNvMT/Lj0C/lzKvz/qIMVNI7IVygW9px2h2lQ8TOsj4rT/Wg
1Hlh5YFTeA3+jAvLO6Fo6Bwp40veDOWZV4Vt7GqeZvO4SNorjI0odgPDO8w7mip7gC+zedO3p5wb
J8Ii1aFfDuFZF5XnTSLnXUEHRxLflrX51crywLIjISo36ozOt5VhVTOSSPMjCvtW2Z1q2KLrqO+m
nYhO/cDPXNaEpuNJDWub6ay380LHtoizz6I35LxhTXWR8zKexWZ9lMc5mhddqh8juMe7ci8e59G2
FUVT8wMFtVB8CPWdZMwKCZuYn4z5Yadp7zulaNrCZl0mHarLJl9YWVZ8qzvLXPYVMlwjCvvz1oyL
057xz5VhGalbxE3R210OrKiLSBO5DPsqsaUOl824+i2elm4vOXosafjPUkOSurMoQGrIVQicN2Ac
KmPwuNC3bL8SDeZcN4GTZobpRhkWtmyHDox6L5cdzCCehs0aeU27SHyEZ6bfl65MQu/rj5fn1KCM
chCK4eADnI+AAvyJ7eywoYOBW4HTdE1+LUPQb8Tz0A3qHs2tImfXJEPVSzr781PH2004IXD5NFRN
WCM6W29vIuZbRt0adtpbQTMLmjb/Qnjh39UxxrXNUl+1CxoN6iaOtVx4Jk3jzO7q2vva5D2xq0CS
r3ldlicG3KRlZxiJY5Z3bmymwfCCAYMqpqmuEHi3kYiFDEdCJevEgBUtFyo0CmaHslEOrfk5CH8b
9BnGdmxxbyED4aIi77GdhVQvqoYdN4Hla6dLROCUZYgcQ1mrjBB9QcOkOIutns9YYYULgybIbYlX
3CpsLENDh0dNUxVOQtVn3OemQ1COnFCV3hWcWkwPWZ6aC56Qm8LwW+QOwusXTVFjN5CVvCq8QLq6
9ZFdolYpJ6h4fSZM+MGxgIi2UWmQhfSTky6wKtsgKbe7XvT2kDf159LCzcwjgbygyPTtovZMz/Y9
JuaDOQR/hJL3R5oJsYh0VMxK6Xvz2I+LwfGFpnOjzdlV2WtzaeSBt4jT0rdpyIqZNBV45jwgX2nQ
0sAZEvjyIULsS6eNIbFzHUU26eP2RBkGMRzOyqOitYoLSvPyY2Wo5p74IZqDOYvPzMzyPdcjzXCU
BnU32FFmcdfXRufyLsenAbU+6jJqF5mFsy/My7Xjez49o2UdXhgRto58T3mzCIK/wy5KvFmnm8Tu
tBXbVpwGRyUrhqMiYc0ixdI/T7OmBJtt+llqe602EzvjVC+h3I3cljlDs8png7CN2sczGuFGz2uc
hQuV4dYu4EyG0xOjXHal6GcijEPPVarIVsjXmVvhyhHmEB2mflif9WHLXBF63UlUiUPBwmqeevSL
ZXr4GOfBJ+ZHhm0V0rLLJjwVPUSKeWoNttmq8iwxqD4hQ1ktYjrI2xS8zUKxXGi7SXSVuJ2faRc3
NeiZanFaieJm6BPvtNSVOBfNIJ0mVskpb1TseCiji5KbF2Zp/BGUYXfZF4O2jaj0WjtrGssN8oTN
Si8qYMpbiwgNmVtG3hc/xvpj2zJxnrA+t1uIhW68vEefIIy2DrUf4WPTjw8xHsQC9UHlBCLur9M8
MRw/ybLLqu/i406J3ski9lkZbeIwg7QXBcv6i0Ya4ZGhBFkOKYSziRYLL2laJ6srwd1G1D7IVqfI
DhqhYIbJ0o1C1bp+2VV/gA7bq4RWf3hZEh7JqrMumiakJzQt9RG4Of4ljymxI4vpOWOp56a+Ebm4
Tta90RuLVNcdd2SHG25HKrGOhlyW8zToPIdFXmgXebDWpLKUHaU8nHcx7UAYdO2pPnRCf8hPaxOi
03lhaeNjBQvmY4uG+FZp/xQJ0s0KApVqEIuZodPIcQbB3twRJql1SQJaOIMo6k8qt66izCdHqVWa
uZ3gFDkWhYk8hDqitpUFlZvWtF8moIAzZQRkBRSa+GywKl1qsD03Ihmy86y09BcIVYPZgKP+pMR+
DJFxbPBowaIusas2adVMlWHQzmnOI9+uImQVdiwD74tRMTaPoyhcF7zAqVsFqToNSyOwQ03aw8S3
rAXMsfzW6PI7nivhiMISjsH73kkCyRYo9vtj7vvVcZiEw3lpFfSY0860BR8+45B907Di5xErF+Aa
5dw3rdRBUXRhJXXqpLKTrpcgtqglJ6smZEstE8sxs65YQjQT809cBnloN1JJCNCGsP3ErTrHbidp
4lKSoHweGnF13ubav+tjXc/gkpDAzso21vagmmFR+3ljF7T0ZjKrvKWM+iAcQ4GzIGAmrLy4Nc7a
vFFXQaQMMAtZGS4SiB0gvjb9pTfUqY1ZlNoNgtONtui72772xXGeaXVqhDTOHJGIaFY1XXIfsix2
ymJIPwvld3ZbMHJbe319FdQGGP6ezLzSECvZkPY0YnmxhAWNzmKZyVnLJWimodxgbikyxY6aThHH
j3kdOb6CYxp2SLrCW/A2iX0b/L/+2uc9+IietcURAjsWOSaxDFgB49rPsqy0rSTslqZnpudhElvR
LKPIk7PGw1Y/CztldTcho5DdmSqt3I7WZudU2ET3bT1odN5EZZg9PilqI3bqY+wT2xuXQS+Ef5Tm
vUntukZBZoMbaa2PRciYvq+llzgaJD5rtIdTRxOcNLbPzOEEAvXerWGtzcqyEq45UHDAUdSEi0zV
3UWr+lI4OdPhIuoGdMZFJtyhMPFhRMH41ilLU6ftUHehuLbAEHtFQGdZ5hfZvCw6gudtE+atayYQ
oxzrsE5gvlYpoGvG4QL+cka46FIhTsCPy0/w8CS/NOMgim69Tvn4grDcqh0CwUgMUTDKknlYeGbp
+Ehkta2DtLpvMrOFSKZEZ1kUFssHUWPpk8OsqMJFb7XoOjPTYklVgs7SGqYxKnx0BlserS0ROGNI
3grh9hW4Kg+8zAlKVclsPb592LVylpK4vyxkTyDmtrS+0cNghLbl9xACYd10FxUFtIyKs+ayM1J0
FgzaSGwIJ8kqyjVMDdT13LeJQT00jyChLO02bsNF6Y1fZKqkWJZdIU8oLX13wDj5mnkS5GjicLC5
WWRfZV1UOVxkJrJLK5M8d1DiV8KRTQQTVgfksA5reJFSDaCNMot45VoGZy38/yz1QJ3acGAHqLtI
CsiI6sRo/VkftMWyKC16riFOVE6CZBqA45T6OOnMHrmcGvKT9DVA18XRYGeFVd4TzeWnfuiD3DEH
gRhEFB1dJR4yPyPZlL2tUddl80yT5iICSuTbIIzolEgt5tTyua0zCRM06FxhpUdZ4eWFUwdUXig5
GDMFN8K5LSetnsWsSuYyNIJZ2fT9PDDVR7MYyCqhyDqlfXHYGgrNyqFUH2XeBUe+MbRnQR00yC2b
ATlJx71rnMRFNyMRvdNBhbDdQjZ1hJOkX8oiic85jrKPdWKR00GalasTBeMqXBy1CQpnrZRjplZK
6RKIJOaCe/wWlXkC1idr9TIvk+wYVb3lci9M7ksOUUduLeLAlNEJ7gVEKlmdLhHi6pvqdXeaepV5
nQVBHTvBwPBgs6pA4VzlWf11qJIxVMlQYLcagQfx4pDaYZojyx6w6hdFjpfAqhCYeDwrC0fpIVmy
KvB68KA4PLZycNO80ugwSohUYDRRAWgjr4ZwgiFvaXaKH8el0a2JiEqXJBY6LLDZHaGoQZcRKSzm
lJD5LzUZ/FMSw8p2kqb/5FnkM8SYVzzwPxaBFTpGnhXHZW+iRVJXl1Cf2tgU93Mgf4pbX2PtVFxT
O4AZf551EEj1NDU+Gm0PUboIi0U/GB+D1pSODCCXNBjtZyX2angWOPrKot25XzX1sdaRPi/ToVsC
iyD+wIGyLtJKasdsY3we+ULNSJGiGaJh6LR94Z+WSeydsa4uP6ogj24aA3/OtEmWuBT6DKt6ZTSe
/lTQLGSOEWTSDqMwdJO+CpfSKz/5Omdf686QTkn84r4ISegOgyhhHlRFbg+sFRAYCrKwjGw+iJCA
z6yqj1WgzNKGlQkUIVSBLnRtEdA+vg8VvZFWfzpUgbZ1Usz+EWpft5Eg1KalOIPkxZ/pliQziERv
FISdYW+em3HT2aqDjA2j4rZk1aWo6Z0Vo8+qAZuem9ll4dVXsRFdB0Fv+7AnaAXmzUOu+sQ8P+X6
jwzqHdAFRegHT3926PnHf1/rFP77cDD+e+P4V4u+/3S6+XNHP/wtuFR63Jkqp780SvP8XSDMk3Qj
+7zzw5+I8P9Ade9uXfw/8eBwN9NWUv8nHnyriPA7C/4w5pEFR+Z4OBZK6oCFg/30LRZ8rHmkEi4S
Hbk5YLzH01FPLDjcSsfhD5eMpIBABC4gAmLgiQWHgw6MwZFOOf7L4FYo9FdYcIwm6bUQcA/P+PDx
3mVGyci3b5MBKViUPCwMBZEdvtPlRRvnws4jBZa9MWaax4kDzJZxUodRMiM9GBFY9zeWmTrekAf3
fsGWTCfflAGhZJdTxwxayyEdm0c8ypyGJSeaQ+KAklkWArUILL6jRAFsikkdDKFlSakjfFMBlQY2
tB34oWEks5aWxO1CGTqBQZcQ614A/X3WGyJ0sPCP/RjI9JimDlb+4PCCw3dg8jFK+NzitTs+FULB
i8QzZgOtThuigJ+iTk7TmSykayB2UeAym7NEX4GPSWzPr10SY9urs4ug43Ojpg4vkz8YJD1xyg9h
v0JBNt6csv62ytMZjvSFAcvex5eVUblhlF10FvwagygqoEBlX2q/bGwr8K7NGKtFXqDENhqSHBYd
O4S6S2VnhrpQYR3ZaevLBTU1mUcB0C1lfavN2xhexUDJCSx9N8CXpkwdBrYXnmfG6SnixpIYZElB
DD8xz/KhWDCS2eNvV1WySLQzDP7C5OgIof5qSDSE+TJxwKR9aTX17SAcwFykDs2r00CNGWaeOSkA
OpjeTESWDXsYJcQmn01QBkhEW/QJ2DQnNC+T+lLpSxMUGoj2U44+eqZ/ND4Y6KsFg6zCotllUmmX
D/d50PyRBCm2sWfZuKDgrOCZJptXsvxSKIgR++LKsJSDmmTW8QToCupUCDRdQbbPKmOWxnSZQgZg
q6g5zWv1RxyRxNYQJkQaEluYa31eubKRc9ozJ879uW5BB7z7lIt4VpfRLe/ldVCZnx7mTULg2+B3
uA7sXhtHeUg/Qsw+r1FmwnxL6mUV0wUtQEp420iZn6pCQsbbLWJPz3ILL5KQLfLSmPVWc6p4eyz0
ZyvMFtIrIBGYNbACGsEP0zBYGLl3XOaDaRcqX0Q9XcQ6gaxsAN+hbU+oqwYSCZr6s7bITgOWzEQd
3hPlS3tkuVsU3WcW5Hz1Je5rd9DBsYpKyykKcRiRfO71ITkOGdeuhsTC6Vs5uHWcw3SK+B9pQPpL
QpP4kMn0JK1zfjWonJ8o6JOFD/sTvebHKQuUO5ghdaH2NZiXjQrmRcAtR/ZauY1FsFvWuTfPWfA1
8+HXMpQw+6GzIDF1QxVfBCQOFqYsgnkOEUhlD2YXgCp6BdRq/cXv5LpqcG43nFwoWDjAjHXlLOr8
/rKKinI2CtSbzDvUbJwFKUScbaO+MQUMempidmxIWLtYpMrlwKk5EaXAqxGWHIuqUguSyvCwShWQ
Qp4O5gG2jEWojGVcVzy1jc5zhWr0EkchvfCBC70KhcpnUKnuik7Os5y4sFOwMLPMSYpwbsb6DybL
4xTHzqC8L1niz7jmR0kHOW2aOH7RHBtA+2y5i30U+l4LPF5+A+y5hOrriQWG3BS2ASC6XXgGrHlx
2UB4FLBbrlNHyA5giC+TXtmmMXwyJHrx6SPHvLVB9OAAMCUSji9acO3j6IW2HQBOWcOTOtYLoPcX
qcyOMq8dt67EPIAYxdNeYgeLsMSz0brChss8GFC4LIaqdIxMY7vv8iMMFLvTVbXl+Gb8LY7ryIWj
L9dNPaNGfs1Z3NjpwM/CmizGb4ksSIHTa8NLjqjffmRd+CWDFD9hhrIbL5kBPzZrCg1JkJXYZgY7
O6aeK78/Gs1ylYjDKmwgk0pc2OE9pOCXjIat0qQ84Y1lQwDojAtnqPihQv5x1vjHXtPPTBm4IRAX
Zd44og7uWn4DW3R+mNgi0YexT52ou4Q5ZjdMBcC/3vqYLNCgbA2bzAw2GBMGy5Aqm6eWHSJkw2n/
RV12nyDsv5Ii/kYjcmZheuZ37Az7/ER6zZEsBiAxhsZ08zHATA1ht+ZskHhZVSGQXt0NmK3DJhcy
tiEm9L5lTBx2YK6NMJ35FGxxoOw2gc247Gp8IQqOlZOjohOdXabpSVWqr1yrJZWw/0bPrLI4yvDH
H0/QkWCfTpBxcwKoeVgZMFN2JwhsIVMJ7JZeRDVsfjdgtYFxLxzN5NzU6PbHD3uIN6ZP4yYUZo9l
hpDZTTaUzDJsan8QesE0P6vDEqxejJygDT6Wpg9rMKsXec7mBjFnqvOdnMw776U3fnilPwsBdwZw
Ykk4NjrZc5ClT5QImV78X+a+rUlSHGvyr+wfwAwhQPAKccvMqiyy7tUvWF26EBJ3CYT49etkz7eb
QUZHWM3D2o7NmLVZTZcCXc458uPuMkCV+qY8UYuWbZ+jqjjiDxCG2ucFXdNZP3+eqiplgu4rpwWM
F5ofnQkPXYBk4Xi7nBkkUpGUbAC8RY80D4+mU/vQzxMChLMMnTvuuI95tGRcmdNaIPQ6QPPQtN89
+nW9AcHSFXhstPOmxiQl/Zh7984QpGR+6+v2JPgv3/8Rl4CNA4P2hLcTTvGPGPtfW2bbNv9zmIgD
EDqwKKhAVy+7l2GiIR56RW7bHkeH4Abp3tHCTedwRGZb0gk3mYUWh6J6UPyLIsPBn+vUWzJG7c7M
yJblwxwCMMXxmYV/Yn39RhHuYms3x7ZAoDO/tGPe02wh/MGf3cdumd5bPe2u7y7v0l6Og7V2RsuN
om15/hUmRnzyR8TacQZi3LdvZou7m19/czhg9Wo6NXT6QUz0UAUfTWAf3dA5uQNqWO3hLZQEUQBI
7bHl3qlT7IM36Md5Qs1JpjuvZ2/X2rMx407x4h+O4r9OP1l/2HZHxnhqEhrbmBL2TE140bOjnQNE
PZhbXCXpD+vwh8BhqYiWxCOmSFoQCxKLyKmtf+KxuyNGv+v7bt9Yd0kMEIyiWp6DW6fGJEKRcSON
0Mu/DyBk4IMUDyri+cTSqqfhUKgW/fwWxaNGPxfBPBbdX3xu0o7JN5Q0iMHssfH9O+GQY4EEQlB6
jyXi+UIfY0M/hco9dGMm/AbNsvejrPc+gD7R9E/OkicAET+T2j9Kt9ojmd2FxZTYcDhyNu0aOu7a
lj75RCVE5Duj5M+J8lPAf13fQhcDVMwoJJ1gneB5yU2+rMIll7SuWnRI6dNajXnudAI9YKrcQ+1W
OyvC01Sat2tGsdY7LcXw4cZPuLiL8boiHnmNUDdEm10cdJ0eLMFP6OYw7dzoDtE0HeYfa5VNSv5A
VLXHVeSXcgLgQACh5/ZrIILD6Ne/1yobNIhbPeXXRczqK8dYCIoJhWBiMyuLZ5opX7A/A/fNwvr3
ufAzNoQHv2sz1pa/+hFLLfUjq9he+v84Nf376VhLpPPTscppfcgL8XwKg8/p+e4zvZc7dkDzd0bh
yZxvrfoUNKggmbN3hf+Ee2rkDacFvyXsiwfHhP+IYv/1B6xu8Vd/wCY69l4xA5VDwpALmka1SuFz
e+xwd8GqAOt/rmYatICjdu3iqDs5qf3gfatDXL8WexqDedeE7xacZxyZ4zD8XKN+Qetk3deRbJK+
U8de89Qq9pgP9b5FvRQJXHVNgO5MGf9Ddfp/Bvb8f4jjrBnt3+mMH1ZPtLb5X3cQNDW/1P/Qp1eq
4Pov/gfLYavXDSxb8bAvmFTrIyT/EBoJTO0BMYOIhueTkFpWltV/oBwngMcfZELYn0BXAPaBjfEf
KMeB6yLFmVn/CDkV/Dn2J1jOJjIBJWKwsgZSCBYganW81nR+CrxK+0MF5krWzrY/AUNqTuFA7M6N
K/GhdZEO6rgi6dg0cj+Y2U9Nt7RZMzfi6yLyv19MX/bP4bvCDPrn1zy/UkfiYOUmbn4Nq4tZ++hF
ZFJ37Gvut8RP6mCuPtK2yv82tlJmN4n6beDP6GIGASueaqu9X+GYU7NTuURrNY9G99PQ0XpM5tmM
cyJs1QxJ55d9gYsH8JK0qRrz8/pP99bT+n/DyT8/HYkWAhjIA1el7PlEUtmPIUgiZVa5GskU2bX7
OExtr9KyYg6obLwDRma7+K4pa7R3bNAWKS3CH4GcvEd3Jt6nqYvmj8FMlyDB0FA38jY/OqiBnqwX
y99ePpU/A58vn6yS3Qfpze9dPjmfr3/I+dXuf76DrTsVGQvvd51/B+F6cH0+lFnoGXEXFb5IYVRM
DtdHWf+WzWzhGdrVnx4EQ/x3/RUvShM4YEZlr+cyqwdH7iYfdJdu7vuHQZT8RplxnviePwh+OtSH
1ZFPPXCCzodC6yvuohAf5JTj72oKykTn3lvlEJ0McfDpz78L3lVgZ8FWDGjsuktefFc0SjTxB7/M
pkj7D0U72jTw2zabaVjfyB8XFioGE3oVv3semM+bswJP4rJelkFkouHlwfjU4A6M/uj1D7o4CsoF
2Kujfgdx7/yDbB245Ry6IquKWhzw/xj2c+TQG2v0ehQEM4ZhXAoEG2Ly81E8EpocPWGRIUAVST/2
IHACUbzxLWSdkvNdB9Cc4Z6IvwZA0CpIerk6evbLEhRrbIUldHeNV/OTI7RKSuDQrKgxgb3nJcxG
8x5liU0oQLwbd6LzmnfdjeDUgtnu43UGFD7bqkMEQK/CSYrMcO/32InhSL1JHzkvzM5fyjGdpqHc
6ZbdOnGvj8FK+UalhVAPBTldl+DFziSyDvzci7CQrvt5nl0/bST7tOjpO8lBULm+ay4NFqAfiXIX
EBVbjUxeDtaSaiyZLkVW2+6L28c0ldweAuL87ZrCS68PdmlKkT7h44QnvmCYvqlsJxFxq/xOZHqo
yH6YdLBfGtdJ+qjjOzrH/ZvF94H91GF7a0OdsyKfVxPVIyILQ7hECbnZtxMfo8bkqsqi+S+ppre+
pXtTFqiy3Luxdj6KqklBf0vnJt/B4nFfLx+4Fd8HUoPF1yWjZDs5/ro+Ha9DK+rp1TfbQ92AymMz
9+EEWnDQLjyLK6f8bNtx2g15bg8iyIfj9aE2jaD1+9fHkwMGbnuAS8WWi5pT7UWAgcWa3uSusXOB
krRcDiYmZao4Zyc2O+Kba3KT0rpW78SQq0Pnt/Mf74GQgZ2H/Q0rTWzyTfY1xB+ifAL1iHMiT11H
9V5qd95XtcvT3G38Q1Au5XuPDfzGyK+3OkYOcKxXGzF0xDbTXVPi1N2M3Tfz2O5bIOw7gEDTPq7j
4F1TCvfWnL8OYis5H7kMr9ohmGwHBHWzQfs/LzNQR8HmiarwfRs70ZvQBkKktaGBk/gebUQqbV/f
OVV5GFYizI0jfmntUaNC7Q5VDoGwYZNXO9D0ra9rkbGOxA9Ugw4SoopJuhEdhwn8xLsxH/QHMbMy
MUE472dqQWyQcrkxI5uL1LoLIzwCi+QOqBERNdjcI8eOAPWxtc7KUiN98LZjOmmFB8LYOIENtxdO
XY0pWii4xznDPrRT1Cf9YNoO/KXaqrSvnSnz8wr8vDavpUqaUbh+0hah150iNYcADRQtY9xG8+jN
oBvvW9twvitsEUdJPTf6K5v8+X0txmhM52Bo3vQzcd6zmQzv6yrMdWJGZcMkKkBw70Y7hjeW4/U2
RN28HseVnI7nzDerUca68GsuVdY6k5cqqAB2iuR5ysEvTWxf0g/Xj/6aLs5TKUoCN4K6lEQhCrnN
nOcQablhO6us93t5WlyoE4Al3Upar2MZRkEMwzunq7prG8vI2PXo6hF81Uh+hxzFR9vrHuqEqryx
iZ41T68+CLIzBBDoz4DVnKcsW1ZR0XNHZajhTzOTxxBkQAJqG+4LkIPtRON9lZObkrw6kegbkMe9
j/0TSHIIfXLgYfMUuP0xrsdfKuKJxKXp+oxfnAuAJdDloIuP+vz8B/J+4uFEW52BJ1fuxwE3G5zt
PLHxUt7IaxcWF0qHmEIbjAQOcOR8KCyIQN5QOpMd2KXV3DT7qB3+vLSMKGoh3GOBSUG5t8nbkdUg
k3TlmNU5D9/KFtqXrrkZHV5XBxgFL0WAEbHGy63YRK8v9mlmx8wfwxiEX/QDVkPm+0WY5UGERbFf
FvAYFxPeykmXZnG9wkewkERGWm/+L4ugkPXQxFs6ZkPD0LUOXJ3WUXUrDl/YFgFiHsM1CrXWqyNS
N2QI4nkYMllONo17AdnMSiid0fW8sS3IhS+CzhI0E1ymKCQ8myxLawh26DIPmWitk8ZNXuwdqt3j
gp25l6Qb0tzT8RvP53PqiKBP29Lr96bo6YcKooE9uobzJ89oev/HRwOtJghTUPL4QDE2O8miv66x
UzUqwGDeU7I4Ce8qm8gGfIrrQ61Enm3gw1UFr5JQZD4waTaBVnc+yBNDgLPRiuIzEEQ5QKroNyaV
gznytplRbywNosPkkh66T2NBeylEAMneZArolSal1cFGzZdydLwg6eO2bvbXf+WFhUJpAFx9xXYg
8NhMSG2LlWXd4mixIE9iGXXoApbjjWl/7t9sYubZMJv9wFjn1QApxowMHKxMS4t3PneGQxgYvssh
R7srDCNZF8TOO+bmIK4WxjkK8NdTQYo5ZQtnN758I9F9LgYg0l0Vl0CQ1jv4+alrtAWTkQQm61qn
eyNq1YNE0qHJYqDM+hkSUJcSvjRKgH7oROEBXIEhA+bUuamatNZgGRargiziXZFyxkMv5YUdvMTE
IAikGvSfeN+HozrwwPFMspKBQcOcnC4LW5RlN6I+XevHzRzHKC5DP8J9cU2F598TNctcFG08ZmVP
1V7yQRwmS0naQDeAtnLQJnUo/hYMEFeu1HSf63sjj3o0YJxWEPPYpioOy8jUbuginVDrAZyqKg+c
PW/6ZZo62g1tE6Rc4UvLIPjN9ehnkT+B8VIK700D+vSdESY+RmUU7QxX6s7xYhfUG2F3UzyYw/W9
+/qAIWj6uMJA6I0st707di4bcUl3Teau6k2u4+FLGKKxL10qnq4P9fqY4O10zCn0B7jAocY4n9t+
Hic/XJjJnMHSI1fV372cyOm/GIQBgXr+Hzh954M4tNcDb/ScAckzu9bhLAWC6N2IS6/rP+BpYOMh
KgETBmp8PorVyJ+oHOaMh+Iri5wDRDj3ugXZGv6Jt0TNl5bo2VgEZmdoKLmbecuNH8i6zWfUSgPk
YMtkD7V0gbE6/c0m0aUPQ84Broo7JiqzzVhxaUVuA2mzoQi6NC6i8q4vpXfwevSsp8bp72Mr1XdS
hp5OsXzhQ2QiNGoD1aoYPLk61mkpBgru9VLU3lEzaX4LGrnDjZN6YTNBSc0gXEQ1A/blJjEYBYaC
i1ScUWu61B1jnqK7Wd8Y5cK1a/VRQo0K6hGqmi1yCg2Zw2qC+UCCcz/GSk5VSqQ/gPIRQqaQDKD5
n0TRTmPiK0W+F6MsCvAdCvUhHwuQ8a/v7gvLA9APhFPgWUi+WxQyKAo60LJbMrOU5HskQpY4AGPe
NQx8TVSOt5Cli9//csDNRudRIXJV90sGONy9s0tcHQcfZPIK5gCQjqMt4JVjc3KYCuDb4HUHXVX0
ELpNeLj+5ZfWmwJwAuyz+kusPZqX5R0vIHsU9bxkbTDqEyOWHqCduIWMXsAs4V2BbR+ufZH1zn8+
TFVG1AtNsABiiuhxAuS8A/OreJByiE4On/y9x4x7hI6b3IvA6T7mkIvd2HRrHj/PQat/Bsoe4MAE
l8s1R73ADh2oWhorxyWzOKdQPdcWVlZrI1108oQmkU29XNs9vuPnMEzOjTLj0kSvbXNQMAjSwbbi
IsDUteAuVnypvtK+heZP+vRW3bB+w/YbX46ymWcr2r7xjEOyOrTV29wVMTkQDwqYXUy0frf4ISCU
Kq9GKCWpItlUDB7wha4Oj4sGMzChwNc+FrryowTSKW9K4mkAy7Ss4/YAPd/wMyondzyxqidodzuL
FybEjcSbpod1Qdp3vOhvnM3nmTn7pghQIAVJD88z43hum3sBA4+CBA7NhkiC/Vl2DoTPqgYBs4C6
PjKdjcGpBq0/obPXPsWqc79AZ+dOSddHuTz4Y7AcYafAfudycNyDq40DCvBEPv/ZUYILGJjkMAIB
5wAx/tmP4sX+KssotIsAkTwnDih1hC5HE6vyRorc7iNAVbjegyDvYbwAm/l8F5uwllTrYczoIN5P
vYmGRNuK3LLP2EZEDIPrHlpA8JFGlI43w9SDrqN+GEzm1TV7U+BymXSzjD+BjAOeegjB4I3JWyva
l6sMag9qF3RMUfGiq7ElY3aw6qCoXdws7yn7qSXUK0lPWOFAUzdNRVrBHqBLWlS7U4q/AzLyoqLg
ipWowX8pKtEKGFQx5Mk08fILg0if7HzRxAaULQUK+hKMIDzWqGHqlGkeviM1FPHYImH5l8K/3YJw
4MC2JWxG9WMYCAQ0Y8ceuHHAYAOz3YU9ANiMRRo2OTCzkgyqTOEkvSp4VanR7PSkggBuCKasHrth
3nEDh5okAApapjrgIM7xgHZvSycaJCRoc/fz+hRG2wCHpO0HqxcaGrigEG4D3DgSVzaNGrO4JFCQ
4tq6nGITuY9+/9Ph1PkUyMV+W3wR3sFYoE/ccKzaHXoSok1rX8T3brt0vxqCTlwilxE2FbUoaZUM
snW+2ImBYGQNc+/5YFX3hjC63JX5ymVbtK9/cB51/ZExHZ+wvFiZ2sQ8c4dw+MirCC2EoorCdFwG
6SZi1B19OwoKzXKua31fj5o2ULGCEQ0BqyyxqWOn6PcjnfzPI9xYh6RQAqJoGRRR0sUVyMyh8Aw4
JD0kVry16nMHcf+StgMQixTwOoPOtRnHLjGQDD2h2wcJaxASfm8D7feJl+fLfjEaco8ytotOfc2G
BQwZAam1N/n6kyfhUp1OoxojEKB7wR8iqLTfOsUyPbVttDAQcd2/sMPAlHT5SIakqXK4DFnWczCH
GTdRKikEv8fAM7g2dn3R3jXe1H4spezLdDZzJEFh6eS8h/FEQJLZ7451U1t+QuNpABW3yYfPno+b
RDK23AagEtOveUjgP4DgPEQ30MNtaFn3z0okCgCFuisj+zy0KFuX3th5Y+aOod6Thg77Dh3IP6w4
MAogLDRhGbgRaLmsv+JFmOxAqvXapkEp7EcyafAxd+AK9zfS7auK459hQnwQjIwhNtrcoPNW12Pu
jDarlOpObqiXvYRUL9W89I65YhmpcKTLuLUHOC0tiYqlunFnWpPteUjDWUT2Q5sSPRXAkOdfmvc9
ZKkTLr1L3NUQkHRf2hbYq0Dk3RWTMx4hRf7regx4ZkO+GhP2LqinKENhtxmz1ROjTtRPWaHHKE7m
iYa/wQ+HPgE2WPHvRnfT77gIcTgEW2D5E5L6IJclzkKYYKSmrj6TxjR+MtJx2ltiB51EpgDpXGuv
ukHtXO+Mr34rmk2IWUDgQaQ4nx/VTPChGCGMnacJ+igfDhY1MXEqAaikksDoB546Gncg1qXXp2l7
9Vs3RwQkfs3Y6Pc9e/u82INjAZx1zsMpq2IkktlRy86BJVPi1zehtgsfCUzPRUMDOjMgCmuifTGU
0hQSxhZAwBA3HJLkeJrmNCqXyU8YbfpvZeHUM+zRev5bl2PZ//mX4pCtJCu8tY2gR8+Hp5NVrQtG
Dhyf3P6usF75FDTTnaEhYuz1Sb0QPiD0I0Db0XeAqmODo7V5kSuric1grsVTJCKTNJDt3ggfr+A6
rB2GQYscPrzP7eHzL9L9oBFJiyXLZz3fRdzzH3wEmxXl0vczdGeIjVbuc+2BHBBYBrqSo1Mz5mpf
Nx5Z5XK3yu5LvwmXR2ykNdjgXrf59GoISgJhO643ExoakFj9jhygGL0o25Ps9G8BuGpSXUrNAEb4
VMjveDZU30Fu4x94LOYb14ALgQebGxSNdSUQoTdBoPGx4oY2+DloqyRQOo/vKjmbPcAydPtoO++W
0bq768v//LdujvNaKaIGBrweYdOfL0wYVKKjncUNB5SeY+mOf8vQzjsYTsDSboE9GORX3luI96AL
E5Xaw0hh2vlcR0+4L7EjyHkE3XbZv4FA3UIGAsMOEIOcwzBCGjlBAP/TxqW5oxxc33mKKmgCiH8/
uT7095RDbkxwD/A6kiDFOg+eRrd+WozZl01TA0AccLxdtq8jLff9rKodaSx965dTc8Nj68KJR9Np
7dVgMkAL32A9de+OEouyZAWMzvYeoI5dNFUQw3RDveMwFEml1xcn6dBbS7At2nE08OAOOgghCSL0
vDaxptd1UMgxX7JO9+YtAQUSauIcJZYHwyXBh/Z4fckvnHiUmoB1XRdNIHRTzlec8WVZPFe4WVE4
085VEAqCWmD+PIThCXVg4oBRwd/aeg8yyFTKxZswSs3guQTWGtgpHugowo1uDPUKl1lnEE9QPNNc
Id16/vMX0bqBP42YFSdZDgejKQ0L3lPwG3tzX8zz9CWIOYJMbhYOletMIIGpAgZPP+m7fVq1g/Nf
xFTMGColdN/wOka0OVNTyx0L6ZSbDQtiqlkmFLi9d6v7dqFqWFt8KFKAgMFDcosCVT0ylNtILxtg
9XfXaOL1J1cBaoShh+BfAJBCiJkXRZ+JiY64esmSobBeVPmXI6O+SGEqiFYCyHxqF0ZcPdK5Yiph
oSFxSkZWRDeCzeudhx8cozO03lNhwLeJcGKKAVrZAACGa9Gg0wOOeT7SG9vh9XkCsg6GHcHrbnjt
YFsQ4xofLeHYehkLEUxGyvkjJDvxQ+lpfudXMqhupNCLAwJ9XXM1GCDbA4W8VyxWLV4W5hFffbng
jCII2efY9Cn0gfmNA/yKL7C+kIzW9f8ZcLO/AACQph+plzUU7gmsFLuILvelz96IriwP8OyJTmNN
yyMjkLDCpjPa16r0j8Bk5G4c2/49II9mV5iA3APU/jZLGA31aAzcNeHiHObgxoq8Ltzwe/GqdrQS
vSnbVvXKCxUdF/xeonDZHmAAcjAapphz58f/zVq8GIqeB7cYJc4yA4/PYh/WQ0AYIJetlmAXGsvh
4ilu2cle2tI449AbosfvAog+H8+qYrQc9ltZR8P2TjsQm83zeMs0dz0Y50n6+XxjBfBoJISNmzte
3sF5xUgPOyzooaDJe5Y1oRT4pwbCZW+AjYdTx1+u54nXGRHqdRwhF68gosW/lUg1LpniOpI0g9op
TI2ufrtdEH0cccA/EtrIBJ3L5XteQgV8feBL54kxD+b8K4cQ3MTzOaWhZ3HMBM1m2JycELvtDp3e
5dGvKzSUrTfeGO/S7EaISjhPK9a8hQADjso3xp0LTdTogyejdmdta+7aGl1OeHWN+5IF+un6N144
EtgyuFnAaSPEZXOD1PVLhfxAqyUrYdu488LB3zforMDNKjI3LtUXtiiIieAdQ6+NAbegYF5OsymD
YckE7d1jw9lbsFm7G7fCC98Dam+E5cIgaA5t1qyhsx85EVmycaz6E6o1vls8NETydrilLbw0VOyB
QY3bBDqBz5S8F9k+jmsyOJ2zZI6OvHeRIuNnVnrQFgtZ/Pkqgd4Oz0G8Rw/kY/tVcrVEKzy4AdcG
Dro8n752yv/SypJm17fDBeADMkl0UEHmhKjwFYpjWwUrxTJ0s7Bzl6My8fBEee2mfZ67B5xTfiii
niRdFU2HQA/NPYzonLvrP+LCxOI3QI4GnSk8TLdhuiF6tDUyeBYBrj+UUzuiryegAAaEeiMjXNiT
KNrwzDnuCKvHzCaDlV0Bf0DwZbMJNeEDuLvwohsG90YEe0UaQqJce2S4HMbg8KEcO48kbd9G9bQW
HBaObz+pM3YpPGy9PcwQvXvlVvzB1YW599jip6MR6lRq4T7WovDeOR0lJ2O75tBIMEquz/QzVLEJ
6MAxXFzv197/q+o4GkRklVu7mY1HcSqY4W8CI6YTXvv8NkOOdQTdqryvqvqLVzTNG2bhs9nBlg0e
1CL44lhwvTXyKLgfYHb3JpB7pxmGnW4kIKMbKfXStsBi+bAgBjyFVtj5JMKBQlpg927G4AV6dGAH
9n5iPsy7gvyWAOhCyln7jcDfQJ5Bw30zlLf4eVgFBckq2A3AmF5Wb+ehah51KFQK4RNZFVguUoKn
f11fkUsfiRQAl+UA76jhxdnzj8TVRHEByzXIM3S+2s38pQITnCpBpv31kS7cVnDRxH+A+XvgjLub
kiHK9SKx+l62RN1jC3T/SIpa/wjhy/ihonAsqYZKJQF6K38ReM1+ChSs3igrb6SFC1kPgQ0XXtcj
ayDdfPHM4SO+DJOXFd5gErH4j42JVt9x390tAg2qvCAfrn/6c7zcbHt0rJEeIM8PkPfW3/QidHds
cuScBzTrCDycoJLg1Rt4L6EJiJZkJRMEtfsaZpd4HaCFNC2B1VrA4JBTNSVaMlZmTR/8Rs9w4DsP
jZJ9bN34Sxg74Q/HGUvnwFmxeoqXHZCbkcnmtxBmNqA+Kvhn5pOqZTI4MMzbR8yBdjXqY+8rGWv7
aIPZHBernfCtHyh+z3pAFasLTJ/CM6F+yKUBg5MuotdAn4NO7co295e0c8z0AGHRhBbUoiyUZC6v
6p0lxdIl0JygPT1zEr6jOdphsEGyqzUerkdtAjPDCG2pAI4caWXz2TlpbJVjwMLmwXWa5iekXmGI
RwpKB+anIUhgEES2x2WOyzbtNWx8qGNcb9fkUOHCfbCbvnRLWSdhTMWvPBja7k6PRaATDlPGLqmL
Dm0WWM+JI8tzOOpcX9lLmxpkHIIfBfxkfUT+fGUXNJfA3FU0A/PlHVs68kaVbPm0NPP427euudeQ
H+4Y+njfGjd3YBMzd+qRLG11uv5LLmQWXH/A4EK+JiCCb06X8aXjeLmh2WSa4g69QWgIWVQc/3iU
9QjjSQUwkGAlsclfDVNeLpycZlVfRofIncTe58WPPxzEA0BDQLaBiwLYVdu7haeNYC3VYaZ97u45
rNd3A7QmN1Lxq8iHUeCpBtYbCzzISDaVqB0F7GsNYdkEn0u4+HqPsmPk1I8AAa5/z6vojv4UDv4q
L0aZjWLxfI8YA+qELqWTtTAfScYKT1K4VqND7bn3UyMCCH9XS00fRkJ/PDAKqxgXCkReaEs3xWmF
FiuRhjqZHThJZKnViQ2dSau+RnG/1L+cqI0SERD56frA/9z9zyIeSOYrbwWiP2/lGGwiXg9e5+LQ
Uj5FiuFSCiwHxlVwvXw7KqdcdoKu5qktGeDU5nviFKigg/HcAkZvDaWoX7gGR7p24ne+juOfdSvY
53IZ+3eTK6W/+qO17UegKbBY7aRt8gMpTAi/6cnC/Qs+qjmuiLyHdp96EgZxam7vezg69Qnr2nrc
Ibqyd5IwvMESj2Hbp06lwBcfJJ/gmNQVXVJ4y5zBoaQod5OsyqfQiaenqsb5S207NRkAhvhxwCsI
3wWUd4jbCmY00LuVYyadUH4R/FnIUBvzN8zSx9UuVHl/EwZ8M7AG6IQ28QNvfV+9RRAV5KhIb7/o
wBQ0jcFfKA4KjntFggJg/jWPAf1VD4X7G0+4OOEbJZQHEzlwNeO9hmH60eG4zN3ZoITbF6Si6m9Z
V3cOAhOif5FDeENhVLOcHAn/eCti/4MOFgcfWVbhqTcLgMMktGzZj7GElVYN3kGieGD5btB0/DVx
qGvS0kzFvphgfw8DrrhRe3SkyhNxKg+2t3D/hrVfj1Y8g7/EIW+95uAWzl8jTFy/1D5oGVgbSKae
v0rcA9PzMzlY8cWPesVTJ+eBSMeJq6/aV32/j1FuZdG4iIMfd8VdH0v5rRpG6iZTN9JHHkCjknBd
4Y2XGYzz4sbBeR0bsHuBOqAthDUGDnB+YqG0b8KG0fIJi1DuCN5Xg1N6Xx+thAX+jaOyBubzkwKx
JiSDCKs+At5Wz+g6vd+EYySfwMgoER3i4jv0fTbtHac7qdiUhzCfgjvZoqPOxeKdKIT0yyLJA1Nh
eeM6+wqCgIQZ1xPALejJQry9TsyLQmV0+iUaAX880XAyCa7qeeLhWRy8dmL8xFW6vnX/W6Ps+deD
J+VC0QhUFJLjbcNREIM7GVPtUzsBQqLMWY5CQiIuWygXlymyD64M3b2rR7lznPxTWVf2Pew4xN/X
l+FV+vSASqyWOFgL5PJ4kz7dyOFR1AjviRV5+xDZanrAQxL2xmJfGGW1pUCZsOqu0Y04n96CT0Mf
Ku5nJQBV1DwwuANBSt7YvRdHQUIDVBohV2/FuWAOwvm2s3421Gjbg2bDk2LOo/31GXud1UKgiigF
wH56Xr3zbwn4PC3uIP1sURBYcPQObWNhu+WiYWmmlgFYBcTd5WH8h3JucC+xMUNgO6usG/eJ84Eb
+M3XplT4PC8eYLfF1Pdihr9YbGJ7L0NjIIpFb4fB6PtG9fOMBJzvVoDaK1McuK6HSmtzPJRng6ju
6yDLa/vZ4uWxj2wMxW6iAb8nMFjUbW/hGhrwHezk48eZCFj+VEft8B/XJ//1OcUPATiD1A5R0Kuu
XdiFYQWztyBT+TS+CxbcluEDO3gnUUP3knZ+UHy6PuJapGw/HeDkKgsEVANCzPmsIxOKri5pAFP3
ZYExX1m/Kdlc3NW2Mu/aIXoQXQXtr+AFNtutptrrMhtrjqsxpLcrXxFUv/PRp5qzuS5REkL80GVu
U3anCW/9vJu6Jh+Txdaw+mfqC/eVL+BUVfdP4NjAqtQTt6CxS4fr5S/ZbAFcw50ykk6QNQHqBvRj
IVk1vri7PtvPUf98umE3E0KkB6k3qqst52MG896MsCrJBrd2wA0Tlfy6PpvwPUAOeB90IJem2o2q
ItWdpl9RIBC1y7UcwLz31odDOp6bIi2Y01SH0Sj4dIZgln5FhQBeW1nZUCc9uKZdIkolT6hHgxGy
xvB/U3ZmzW0jabr+KxPnHh1YElvETF+AAElRKynLtnyDsFw29n3Hrz8PVNVzTEghHl9UV3fLcgKZ
icxveRcbbkEbSV+buFYlSFZJt08VZWg2CTjUH2NNEPPxm76ztITFdIAhCjI0iMrzpa2KkdiqtoyH
aaTpXTSSdGU3tX3HTu62IHthAU1j6Ai1/xEU7ROuX/OmUVT5TzGk9BjY2pzMFAVk+OyrLYbpx9AP
RWUghxXWR5T0f/IxD3szzKzrQR2zC1fBsk/WCwy6nCYDrUGQT9r5axd2jHFGPxgPVVbCnJDN5iaR
2h7nAvr/F6b47VENaRz8MxoY9GbhjZ+PpS9Aak4r80FUkv4CYp1EfQqxLFPte7VI+WKlVvqqTVLz
qU+n8VYb4+s2tqW/YFcRIqtZoHuB6luJK6uZ/2D7doAlhJZEm1zppwuAhPcmRgWRsZBHOW7W8ZCZ
ylHZWZPxMJjBDGgxUL0GUCGMukb90wYIcQ57jgzzFQW0/sgSoxyMqNTMh2Qo5l1g28pOoqp6XbVK
6KkV8kZp3A8XQqx3FgMCA8EGnlvQStZt2jzV2jle9Ph1jFj2QEsYOcgML7Wlzp1C1AuDxcGSHnZ+
IS54W2xHA4UrE9wtmiwAk1bhR2P4CeeoER6HJjwiDa57WV9VB9K40o0qVTjjPMxoDvv2UevjZw15
hQtb8e29tTyBjlvFEu1ScT/fiTgA6apc6OERs0N43hDnN2UddY4yg+zrwPZemOx3xyO0BmnC8UJH
43w8nM7MYMJe7BjT8t9pVpPtgyoTm762EAiaacR//Kktae35V73AaCAjIVwJ8H29uCEg35RkOzrK
i6p6kWHcEcRXOCnkzgS60knDuLlwkLyFQ5CmUMuEh7xgTmDwnb9jBwy5kTolOqr+OD6iSFE0ThVm
qbgNEKDsNn6elp/gHILDTdTW5FLoC8wsw8qf0K0Lgphun9oPg6OJaDy2s6H9zMIhkF1jarL7WKux
+vt4lt653XhkwheAfpxM9ELOH9lSJnpZWhkfMZqQ3DxC6jtIMvXrnIbSTs6lwC1bS9mXeL3gm+aX
V4lWmSDmNemRPNnyEB3T9oaVWPsIvIY3dQiQKH7ZHc0mjw4tzkAetOcHOWiSxSlCaw5mYzV7A5Tm
AXSRgrKAHjo5ye2f7zf6R8hBcLAAy1mftKqvmHUiJfFR016Ar6OzHWaLLdYYbWecdT6exnc2N+0Q
ILsIyREGv26M35I1NTB6igJRfKQ60nqaPGIXNtkvaFdPuykLnz4ebflUVlub0QDr2pgasMFX2yyl
aJ4pWGccAadZToe93U0hhxmOSk1zYRbfxljkR8wfNoJg77kMzrdHGMF8UqM6PgYaDilqv3hqRvKf
0uiW9P73UVZluXbo4PCrTXzsYhsXERWVsnxWzD1eoyZc9vzl4/l7d7Wo/S8xrEHvbzV/8jj0ptXL
8dGcdPFYdSVyvNNkbsxQsg/dEF4qCL9zFFE0x2QPLQaqtevOTooKbU7qEB8zDlwPOiYeOaUR7gaV
6FAf0YWB5XmJ/vTeJln6xQDZX9lzq/PdJBDv4CrExxrG4LVVK19RojA804ovkc7fm04aBkggLTI0
kHDO9wgVqLxXKa0e8Xa0Kb9l39RKebHS9ipS1K8fL907+5GeDem6CksaNMEq4wybvtOVlFNdV8py
i1qf4ZXZdEn0eKUdDNMQhDfHOPV7FHXADK03ZO43figLDnI9hnEB8L79ksN0QX454axywE7oVzIh
mUsXmVom1qBt4PhYy4Dx0jSk4gYh/+xGyGbzPBQb058b3bOGeN62vT2TJ+VDMl44y99ZB1gYfKPw
xhdRzdVRPia+PvsShd6+bqB8RKLbzmqIDaPdjdsJFuWF8d5bC+hCcD5oV2oAuM/XPUTnp8YyIuGE
NcorApoYH/Ah3v7xioMMh7y9QIAIRZe3/u1oTXyWqar17IgckaAVRiw2kWj9+QFuLS3fRauEMo2+
fE2/jWJkkyIKxH6Pthw3B2xN+UQNO0E0dq48vMIvivG9cyYsgxEmQFxn/6wmLxvrCSZHkB8HhX4K
qMgl6MLGWOpHeWeBDtjVYTEcs1HYe1GglBantv69VOfcJe3XITtRpm2mdNyCrFRu6s6q7sTs27uP
Z/+dU2Sx4Vl6WRRgYfWdz8vQWVkQGFOOUUyXXOP/aV9PdZW7bZtd2r7vbCdWmYofLadFOn81VGuJ
LJ5bhsrq2HTrxbGwMcpg//ELvYomrS5PKJDgCDj7XwOE8zeKQ3+huyXFUZZLbfGa0g8+2+vrXPWv
X/PsplnRHHp0/T1inWJbgrq+RRWUOoeO32OJqcDWlMqfdVlggKHauVf7LEM/J9GV0afPaqy3qCuW
848AAtxGSHN4IS97b6ZAGtDjRPWNsGOVPOhdgJ4hILHjjG2bg6ve7DZ0IC583q8AsPVMEUKTri4s
G/Bb5zMVQM4Dm2eXx7wVCdvx1cswKxFYk4B2pm6HdexLmMDidSu11T7PU1CaziCE/50Og3LsR8wa
fDUoH/PZMF7wF22arW0STBS66v+A7IaBiUG8jMp/3Cqlk1j+pYT7valaytpLLflVpvD8HWa70qqo
SMqjJrCSURAwC525yeznj3fVe8PQ31vEjKEvknicD7O4xYepb0cka3XpCIwB3SkKL2WNy9+yXpCF
F0YhipoZxKfzUbR0ylitPD5iXg7nqijHxTyy32ix3ezsefg15ea289v6afGgvwDWeMtVWXBor3U/
BL/Q+V1d80pSyTFMuPxYL86yc6uMn7UQ1SqIPcYu1hT6MaWGUye+TOHtgNSnVxq9tYMrGm+MsNa9
XGjFBRXYdy5qziZkwQRUJVA79urO64I2CEONIqOpjcH3uuFbcDTwVc+T0Uv42VQqbVV5srAImkR0
HVe1thc4JRsOHxHGTRF/6iU1FdKcMYrhgbTV+GsYF95onPsyzTg03C/1Hl5FCs8XElQ4lQ6a0MAV
ES45X8jYz8YUUicpXiPqE37JxlMaLIXBgFYCqkkIOBaupeI2ikmGWV2B3ix3yD9H0maIoOhsKt3v
km2Vd+Kl8GXltuXltmo+svmSEWsXtzO6GB6eL2FY2YAaDzFi6FR7IyY1eeglAY3GLKXmWYkyfgZF
zxqcpOh9lObH+N6aoslyS60aSk+Bjpy4Leayt3oXBrqbhwaGRFNggexviP3Al5eSsdWqSYVgYTVR
sOlqDRvGWa4w8ggBFF1JQRfKB07CBl9HU82cFAWoo6HUAv5sPdd/4YiMnJyY0O8ildu0sXmHpg+E
lAEcxazPxo8CjZTK8YVUf+paFe9HFd+073JtimQDGFNDPq1J8h++3xfPbYrNoIekRL5vLbRINknj
6yrE2UBLOZB7XJDncZTkQzQkRkdttUC8S+HwRhHXN4GGVFmuH/G1qrDnoWzxVwJRqNpMdkOXM0ZE
CDuoNAQb0zWN9WsSJY3Tjw8U+82JsnxqVLcXtV6D2tRqY2uS0KO40OejUSWgfDgP0F+sihKTLyWy
Uoi/s2lspm62851kp4P8FOtyuu3VHD08wBxKck0Hbyydpqi1n+o4+p/0vvWRv9fiYINFtsHXMbVy
R+E8Vb+V/ey3GwhvwzV0dxkXU5bgFHX1rHuwHtXnyMI/2ZnmGoK20GoUASdlvFbHdsZWJ6wrhk5V
rI3A1n1HeGT+jPk4H07VV6WGD7KcPijoS9Eaaqck9TqcPv1NUUR56SVjmb0I9EtVt1CtVnUHvngd
aPc0wJ1ILbIzsy+15xFT+asWEAXmvxgMTbhJ9BP+x0JQdxjTVq3xEUPtyWwmoFaF1tv61uqw9HUk
qAwtfPEJYRwTn0kvL6bMxVIJfzetQgKhCjC98MugiMA0BmG6yTBuDg/Q8CSi+lgLf8lzG3xBLDN+
VLBxpy5ZG/VeKinzb4QmTbJDu8X2hmwGQgZkd4KHpmXzdQJXOfe4/cQzOrE+h2UXBN/9KoD7PkBN
cuoBMpQzSYMubSTsz25DbvbiLmgTdTjEvi73O2sCGrad66J4/HiPLSHm2SlE+24BhXB6LACctQGF
nhkCs+u2IbJOh41eluZBqPXRb6JiK5A92Prz9EMuSuVC1/CdrW1C+6LLTDNlUWM+P/1QYa7q2Bjq
oxHO/bbQ5dJVCtB+H7/de6PAE1/KyjIUszWoCCeNNkYQh/6B32sHNhB9yHK+hDp7Owp2BAtYE0gP
hYR1jNTMGV+HnPXY3+rTJtLUH2mhle7Hr/ImCF8klcjjKShaoEPX7AC/RQQmULvuWKAt5JIMwGOk
T7BNqjq7kG0tN8/5nqBaCkSJ1aHuT/3sfG0GpSkz4rLxmCOfu+FznD2Yh9a1OaXYlS3A8I9f7W0h
nErw7wOu8qBYK8D0dON4nMWoeDYcOrz0gnajJSpyD1xEOwU452dd50Ysw7h2KKkXF5K/d+ZXR/WC
RAfQgY3Kz/lLCzOImxrjuKOt5b8KW09u82lWuIBl68KmfNti43VVkmZiUfYL6fr5UEYdJ5VeS+Nx
VJViJ+Ekd13D1PNqMUzXqm1hER4MMXaRfr0PeOgN2K3OlSr90pO8s3EXdjdyrwuDAdTd+YOEtiJN
EaqmRzxoyKhxDNsvBdILO/e9URasnQzobnnx1czmfTz1ep+PR3mWgkMiqV/pSpsX0qF3lo/JBNdH
u5AawTr4RnUqsmYqiEfbwGnKmIsMS7Gm9THwkK3Tx/v1vbH4KsgdbXBJVETPpw3dt85E9W06LtxC
J5JU7T4Lwh8hifgFPM7byjxlEwyLoEIAL1h0LM+HMhI/k8JAKMcBuCopkmzm8lYQweC3Z9td5EZD
XKJDOmYEjtmijvckS4p0EzVjW2xiZgzLa1MvHiqun8GZOh9LBqLSeNHjBMff+hkOhbFivMy+r9+n
EVfYph6HX+NcJD84u7vpOhuk+QpqKxecOc4iup39Ib9UR1rOlNWZg8oBhVhk4xbpymXOf6u9iLHo
tWAypmMXpPUWW7HAHSjAOX6JX5hZF7c4txsXygDvrSMN2L8xRlT6Vttf6rtemhJpOtpTP7lmD2OV
Rr/h+VZ/iXr49pqltgsyB447SRNQmfPXo5mojwSS07HBMZP6jiITbwQoV0oz/xUh8edULnKHmCm7
BJ575zQ3QcnQb4ZVBk9pdZrTUJr1sEvno06MjkgF7bbaGCoifcHA459qNC/XFEh+tuyCSgFDdv6m
lZHWvWlO8tGGTAIhqnrSMq29GgcIzx9/hu+co4DRFkYNkQSplLYqgXQZNM4yTfXjDF7hybfpnMe2
xQauKghETo8k61Uh0fJ3ciNFFcSe7VF1gzIBMFM15uePH+ftMUdZn7ycOxq0AnNw/uKiCnoOBbM/
JkWeQF6tcWUf1D+GRaBIvdBukfhdigzm6kDIVTuqKrXSj7UIk+3Q17yzCt5FaS1EwftWuZBcv/NW
Fom+vgQ36M+te/KWGqRVF9XiSPNw2heW/DlNkUH7eOrebtGlugR8CjY+LYTXPOi3j78rm1ou4sY4
5rWeHxKoF/su0MKdiTHQzkQM5ILx2dvxiAmpt4LBXhZqLZbsN1U6T2IyjlT+lU2mWEBt5SHe9EFq
79tquoQAfPv1QzUBP0SVGiFu/n2+NcYoQDK3D82j2SGDFSd0hAerla4qRX1BLHDEL9iOdmFa/Px4
Xt/yuzhzWD4AckiHCmCt5wMbYYtyRc3EYqg0/BKiMo+BhOmk3klPzHBzKmlJu1Fjqbfh5FNB1Eh2
6TkKDFSb6U4JdcyvY+2lIeBCKS7Mjxa6tFu/NQXGnHp+4UB+W17iecHcIqPAgUXfdnVMNgmOUGOn
mccqlXLPgJuyMTGjfvYLdL/kgeaC7Q+Ri9eVfadPieWaTRB5SltKcM5q1U0GQDAfz6G1dJPObyZY
xxwSiHHwEYh1oxV00oBFrQhPEoWvo11VEone2AEhUMp2+F6MvjiaFdnpZqYmb23jAG2ZTYTVbYGg
Wz0kDsF6cZ+qswEXJ4ysF+yEOvVgYXizz2NMzMM4Bu1l+XU0OWMZBQOFFRyw3Um32+NU6ThDGTl5
nCPrcS3w/NKzz2g4z9eGkdcZamuhDSC+Ahew9KtmzwzjZB/bdp894+I9V4vAQpU4qYlZNjWB4ovd
Qd/u6zA5UfrN/jKDSLR7WRryp6oWduzlZaSe/Nk0t0Tt2Xe5KsIawQZ/zFyDl/lJRxp/TLRg5mdV
S7BeatpJexWoqQ9j2dW+NyiVcgXoIf4rKpVY5rKBwrqxMlFXCJMZ5XXT1fGvilgN+Wg1mL9UhWrc
x1WXJW4xJ9pdpiIntzNNLEsQXB77wOkQUxs3tV+GGLVjm7hJwxTr8qFafLmHYmw9NS31GynwQyBK
pRg6YHpGcsn5+U39laSVUJbdAGSI+ox2/kkhl9hVZtpGp1DVa0+SLP1Wy8z2ayMktDy0vj3UpqR5
RUWrZC6U8UIF9t3hX8tCdEfoh61uc2RvTFQ15OhkTOpTCNiWLZUYG3PAJ5nrRtmH4NE3Yggy127a
S64Ib6I0NDQJXsAZg0lH63b18kaExUhHr/lEX6C+HQscROvQQHWV0stW9+PgFlKwdOELfPPKOnEr
tyqfH41sUrPzGZdSvk2+KfWU1WHwybCY4gjbKC+osQ7Vi8TflrhJOXlSFn9B2KwuXBavYcTZAcD4
pC8a/bmFI79O79taVQaeQJzQ+AePNXaWLnmxqg/3ozUpd0ocUlD0EcrSHEMEHTCXXn/WGmE10Aer
Hp3yumiu+yCbhm2f5+KutgcUffJslge3JGxBRBCpeipXtp9vhzhogJJG4eggptYFnj4aInZFIeyr
hGifIHFG1NxVlLyEDUDZFXv3GhQ2ONsK7fXAbOvmwgq8uS+Zeg5B/gOPJ5KaVaBMEaUeaoKOE1p7
OnglG5gJXATUZGS4IVTILmSMb+7LpVzzWrShPUcXfnme3+KBQELiGSsj7dQYNXk4iNdFtX1oP1Vy
8SmpZfW5Kgb9GTe75k/LUsvICMotfU4uzHV/IzWDGp7JpJ10RK5ctZH1TeoPvz6+Ut4GrowC8A79
VeaS2u5qPjM7Gwe1rLRTNAXFQbbb4bOkDfBGA7QE0zm1NkWqazcKa/uNa+6r1YroCgHiS3HXmwRo
eQ6gSqSXRCb0987nOS1FF0dBp536WVW+5qKPtnZJGylspeDzx+/8Jo5cDbUKgQi0MiHiVjtlFqaP
YyllG+KVS3i/t0cFuStxMUUrpFGBJJy/UGQqMkI7nXEKJ03ZJnKUXQGZ1h6mfKZbkbfVLlA1qLOl
398XedluP37Jt4Us8C9UU2lfAxZ/i/2LxMB9b/jiVIrR8mIr20VhnDqira6Bcj73uXzXzP1VIer7
3rzk3/PetkI5jC49rGaDruxqjvvBlOQ2D/XTPI/zbZco2hG91PC2T9rZRYNguE7SMr9LNDn7Vqfp
U15Ei0RpHf9xGAeoasE+gmwAhkIr/3wZGrszZxO2y0muieodxRyG1kGRo72v+RnuPWgK4g8/ltrG
aoT5awi6fcsZC7FwaKbN3JaR4lazHb9cWJ9lBn4/ysVSd4Pxw12iAlNag76aJAB+DKzoqHZTsBtl
/cYKJm1vikIr8CbJpgMirc2DngC9qOJM8jQpyb83gRZd+hzWnx6MGXhWZOTUqwgv1+AicIlRaFBU
PealWoVuM0ll4qkhIbWdVEm+yQnmOfvRwZhv7FIKoXRnVT1tAmG3Xy1+13dHlLcnkE+dormzZqVL
i2UQkVfPaPI4smgMggPS9XCDg0Z+45vpYDqIpEv7OhX6jwoY+g31+aGGGhg1zxa3aOe02lAODnLU
/YvoZvHFlsvopio4oxwNCRJ7U+RQwTZZvZST4iAZP1va1AJqjbNrPN90l45VrjqEbaXq1iQW0q4w
ynmkhpnmMUUPGoqOAnnkogyZsV5bZoQ4YZEtZO9RxT3fdHLQ5spQVsljIJJavRpnIBtOGwYI/kW9
1agOx33ys0/U9BO+LA3FrDlpH9W20/YE3ulLpMQCSG6EkY2TxXYQbmQD4xBHwd7k14V9uORdZ/sQ
9BpXzCvjGbjLOqdACaposphn7UYqo2Ae0nbT95WyyzS52wk1LK5Cpch2alwnj9OiY0h7v3eVIUk2
lAQvSWu8ybswy6C5AHRh4SRw/a1CLHRUIxA9kvoo4daAHPaeDoCnGN+wGkCg2tguoh6F8T1T4jt9
ZuaKfi/GS9TL9a3PQ4DExysTlRTYBusFJECSJJtGyuNAY3wzFlgZ9kTbh6zBnLNoauMxscbRURPl
Qu34DciFgJYqoL3wqbiROT3Pt07btbpvGpn5OKsPUXrbKPcFPT8LD3HhS65MJVWguBrHJ6O18cr6
OiUCdHa5CfTbzLyqassTueLY6pc4j3dyVnuv2+WPXMVvox9EicWv9r/PPML//d+Yrf8oSsQmgrD9
9335M39s658/29vv5fpPnv1i8+/XHwc/C/d7+/3sfyDrGLUUWn/W0+lnw6n8Osg/f/L/94f/9fP1
b/k0lT//5//8KLq8Xf62ICry3z3CoR789uUsT/LP7919z/i9p8f/+hwBmX7XX/z1d/82GJcM8S9g
gfQT2Tgot1Aw/4/FuGQsRuJE8FQ+aZ6h+cri/uMxrlj/Yt+DCSKkpYqPcMv/eowr5r8McwE1UiEC
GM918ScW4+fBD3QHWC1Lf4vqgYXA61pXWaL3OgS5igFq0m/VCDi45f+9R1hdJv7h77Pjd9/wZYv+
vxPl7RCrL5iLmNrzwBBjKG7VctzhdOAZvf342/y/M8z5IfufYV6R4ARYfC6rL0Xqk6CVZX+5arYY
R94UxeQmuv1ZKrqrj4daWTf8PRb4Nvo5qPUunmbnY9l6UVfyDDDa6vvrUGmvC4ujUpFdmBK7Kk/o
tPbXBfc4ldBDhHoKAJj9FGj7ZXbtYdrJknHh9c+PqH8eia4dbGGEqSB7nj8SN4QC8H70XaQ1T6WW
7iFmeInSXQfLwtbWU5COFwqwl4ZchbRCpSsi4x7rZnLwJZ8YFkkiRHk3+HPiMBc4+mhfOA/f2644
6/zvWy577bf0q7USQ68r3rIEtRXL4SEUyf7C4p5HYn/PJKLWJHcLfpFo7HyM2Jz6wgpaFtcvHmY5
/5ZbYi8xFsjcWyMTt73RXTdtvLHb4oGW0aXxz2/gv8enkgHRUVaBSa8/yVronYp/jI8X3beScHxu
kctp0n2S2zfojh2mIMJLxj4NdrqvMuspbNoLdYUVCPWfR6CuwX1LyMnlcz4Ftg8iTeszgP/ISxhz
/KzW2U1pEnHI1lNezm6BjbLcDZ4WaAcyHsoJakTZENCl4nsob3L/sD58eGyFG/jH16DwHRQ59j0h
nN4VF5qR58nVf56XNUNLdkH5r5asqsvcEGHBkk3GbYt7XCoFnlA7hKntRwnWCTHPbS43Lx9vlfdO
NuhxYB4Wi3fqwufTlPkmHxy9QLfMhxe7zh5KrIVrIzx9PMyru+n6BCUdVsmDxdIMXFXWNGB3mPXG
vpvInwCLPuRLAQfPBK9si60c64e4FweadshtSDfLERMXIcpP0o062TdDnh7LfN7NoLIXQZXRDI5G
MnhZS91c6kLKF5xH07iz4mAroTZkl9V9GcyuMU/uwN6TR+0gI/LF4JMe7j5+N2pzTNKblzNpTy2l
LCAkq7WbUVOAzmrabq7Yn0Ize1DH/jrQ7Vuj8d3UN1yQv4mjIiYyRzTrgFw7bfK9awJMnONDrAlH
KpCEGwcnFb5X6miij/cV229E+L+c+q3w0ZiVqEL58eCR++1zs9+mAC3DwdjPc3zCJXLf42E3J5Jn
JtRmlWmnmul+VHtskWc3aIJdnumObvXeMpNyRI9a5WRFx0VphhezGbyx0vc1Mxrw/4f2cKdX1b2f
favM8S7Umqt4zG4mVdp2Y3iaBkH2Y8+uj8CMk/RYQQfZjW32nt/oi0fo82gF3jKgyIoHvvIbMsKN
2Yi7YEzd1kifkTS5zkzrLwR7kEkZdxUV1imMD/OoHiQ/d/x5dpHc2udTt9Xl+jtC0wdyH6QEiaGl
sL4HeH5LernrYfnoQ3ZdNOkOOYtH8MjfwSoixlCPd+rAZyusz5kSncykvY8QhXbLOfnUT2VBqTx9
QB9mbwtsRoMQFF57b1nSVZdEf1nU+7mMdgUdkLTsUQdVv4BevaXJ/jle7gVdoFKKIg1me13soW+h
3WKYRVvU95aDpDB+hcztcu4uc11O5VbLPVF9ox5XbiLMs0tN/2sMxD6v/Mzh2tubRnlS4uwGrLub
zeajNAzXKXpn4PRvlr+r6CHPzs29nSBdFvpe06Y3lO4P2dAWjqlPu04SnwhkvT4ID00F2pSCZSbN
T76m3xo6G29BGkT9bRt0G/CpN6U97mh53qD/sq8kG6gsd14k7wJFu7XScKcagVfF+j5IMNbswhNt
AZoupZ1v6gHv4kzaxghV8o9DKY1rs+muoFA86rrx1KShN7b1yIHJBqE7fRMjS1p2kGZMvluluWpo
ksi+wDwoPICJRIAxPhh64A1mf60V/UZpJsq37VXa60D4aJ61TKxpXFFRO/kipsdc31ssXCEmV5tS
F6armw/8TsAmNId2AyznR5MjBofDgxOp9VXXiMOy1CFdkcggsLKkz1LfXg1i8JQKWYCArkcV7JpC
AgQC3SA0LbxH2Md9d9UOwYng+LAwAezZf90DrcFNJoJfE+p+lep7Kdpdpho8onnpCXLb5WI11E+W
0m0KJT7QafICprVeliZINkodPTcm7AIyzox90mfZXlf8p0wdL5xQ7x3yYFFgLYGHAtq+OnxndFhS
YJ+2q1n1vWm1myAfdxCQL1z7K8nqv+8wCMGojC1cRmXdYIx9keLrZdvuYCe/Qr7i2oBunxYPIPdw
CxcHOhz7LjciB/dnr5LyB3x8vi53qqz7X8KendSM2cmw2i/mmN741IfjcXI/Pq5X6fh/nvKV2rEQ
VLRVmNlqcZhnvmW7koLKUKmA96WP92PQxT5WtcPIvyVbOShG94KcNVKB486MUUIOiku2dyuJlX8e
heb8a6CEQugqSFH1dFjEIG13GsJT1FqfRD6/dMm0azOagfBcqade50P1PTLxnjQ5LITkfTwd7+6N
3x5hNRtjn0lZY/IIujbemVUQL/b23+PG/PTxOO9tDvo8IP+pooJgMVebsEdED8NebDLnIX0uZXFr
mJJHWrdvZ/v1G0FLywPb4tKS3lRa+HWq7wUiWhqnkO3XV5Lcb2vbvinqaPGkuhrCS3zmVYn3dTm4
v0G5g2YFavq6c34LzQ1seFOzxquiK6CJTb0X1gvvh35UMjhG2m8Vmq+dhNUa+Akn43r7eI7eyf/o
haNkxO1BXXfNcZawHwqrUbbdTPkGTNOzfPVHRByU5pfSv3fyHtQ/4DWBNiAsWzc6pVKYoEIr21Xj
q6zTFsMuN/YhJKjTTisFJ/K3j1/tb7jjKkhiSBs1YPJ++l2rjUZXbczaiCFLQSDGxYGiz8aqg+0S
6NaKGjpmJXnLD5esM5qDbadZpeMPyX7ZERNJmaj0w6TRwBf9NpvVvT6le7SBbmZbPzRzfdW0wdc5
GrdlIe+wpvOqofdiI3NHficbew88w64OglvMwm6ySPpcZtLjmIReXDX3ygRCxbJvooTLL9QPbd1v
okA/oFN2aKhVC0hVWTw4Zq/vKyP+NpFVTaP5WU6rm5qHXn6/HfvtFIdeW2p7eCcHq9Adzeq8QXDH
jeHXJRrrGA8juGu9Cr0SAm+fB7cj+pVK196LyffQ8YYDIA4KQGCLNHv5Sjqbnzf1PZKhD3Yq9kuw
NNCBB7P8NRD4sRdkLG18CMLkV28le41cWXTjqbLnhy4fAQjEPX69hIhRc6UQBy+Rlsll2/Y9t1u6
90PJC2XpZCUBosTBjtvuIKbxh1AxegnGu+X8nmpx8NVvtEFP4MI8It5rjLm4o0voCYQifm/dQHy4
SsdbI8y/AcPfQZXdVIX/WW4IwQ3rhjLEBrTqZolGfXzdmpJdAKUrIPqsiHrNIiCqsW8mADBpHR4G
rd0sc9jTdpaz4GRP4was8m75PQQSt8uNKo/6vh+1W8nmH9wjhyoCXikORdxdZ9anGuxhEekbYXdb
+r5QMdorNZnc2U+AkqUuDcTTbNpe3RI/pak7yNNuCWRgIn+GLqk6hq/dNoCI7MB88slHfLu9N/Pp
ro/6a5Fw4UMCWvZaYPeOnGQ3ujHe6dn9bManuCbobr4Zir6phuxhqRlZPmGVPuyUUjsMWX9VTuFB
4xZqxeyG8IrniR5zMVznJKeoBh9zEtYYwSBXqpk2fjlEP/Ewl+HjUgtZ9ogxTjsam24/cDyxB5cr
NrObq8lMbvCr2AGdZ78Oni3aK4PTFXqeBxHUUesZwqG+WdamljrPyMA5hNKjWTBBEmlnlO71EaWJ
mkhu+MQn/fTxifD28gM1ido0XhGvivLrijRyMXHHu8MIC6THJR9QRXc9E1Uu2yCPxT5KgkfTxK9I
TDvYRU6t2RfS0jcH7qJQwHm/IE7oXa3pfoVcybWsjbbbpIHX5+0mVYXj6+keJMbm49cl011niUsx
BokCMO2Ym72pwCu5jeKvhN+K0GOIWvbkhFNbO1ETnkx5drWZML4RyVHSQw8w6y6ulM9VOH6rqhAk
WYXJpaYeQCTc9OGwJZFxpHF4MUS0scbA2IiClJOzAUuF0Jl6InXJkG7iJDr0c0rnyVrCnGVySdLK
Mth1kb5XJpKCqKDyMewGo0Mowb6ZgYAgjTPujHLaDYPwnSJL9r7fXcNdPBSmdlsk2kFHTKQxoxP5
xwl40i6rhzvbYEdNA8La7eDMVkXwP4lbFJdyl46a02TmImEcfImtGdKfMd/lynQ3tEsGmnJGaWo7
OmPOKThnN6I2boc2/JojSyklxUNbg8DGF86rdZKKkvOyy0zOWPZqTuKo+qda8R9RT3TyQfI4h1/f
vp3IqHPpUeKy3ahZeOrUQHUmOd0L0b5IdfhzGg2NBpG2N/LywTK6q57PV6IU0QTSKYkTw4XK9lgY
+kbRWIGgkv4vd2fSWzeS5fvv0nvm4zwsekPyztLVZMmWNoQnkcF5CjLIT98/Ogv90q7sMmrRwMMD
ColMl3XFSzIizjn/6aYq0o+jRUdI51hPqKuSbtqxE5xTUR1mkZ8Tv74H8qhCh+Mqo1kza3rgZtqn
HflyQ5o+dqOOpnxP/NyuGf0b0u6fCn4nI7MHIxn3+lredLp1xpjv1qefLnE+3dYFjjA7q7aPyoBP
zbsAu3pnuSxR+gzpTPuxzc5tPu+LPn3ctlmv9Z6NGUHWKOGj9X1ow+T78eFBfhQKHVUpcV7AVsHp
yuNIukK19kd34P+QQxF1PgBe62xHMJJTK/jmuWMaw885GRlS6JH8pSNcJj+smwLGyrssPbRwLQ/X
TrJzqRXHYlBXy19iZ3SiQa8/F4X/JHp5tcrywWVv8cYGRhnnL5vySiPV6mSV9hjMahVxTYW2Lud2
KR/GEXWKmT0Opv9IPJjcBRJLX9ev7tMhed5abGgABM14ItJ6uTfY0UyVRjjT7tok3bklJ2Xj4P2P
YLGlt240OHjeSadPxhH3zRW08dTbpRGIEBsgYtnW5NIY1pmR/xle34dhoDrpVnUtPOWEjedBCupI
X7X8/DWopwz8sMKK3HIv20nf1+lvaue/2TkgzlAzB9SE8C5+mdVvFj8VSQJe7MPpwBo12g5ed1uC
dn1TMJ3411vVP/86fC4ZUbOgGXziTfDzTFAXbqassaZBKuVlq0+Ic975dY2qjr2DsLp//ev+5iCA
OYDwBqqwuxmF/TI+W5AtbPoJL27Y9Esa7F54E8RL/cDMJhJG8aYv2dPsFzciq0hPkJEK8ocfF/G/
gAJ+aCr+9yv89xNQ+D/Cif8vgoRbl/F//gpC/gQSPrVoSX8CFbe//ycwaP8BoEwq22bsB/cH74r/
xgUB/7Y3lRMV8QDK2a3V+gcuaFt/wA7H7xzQkNy/H5Nuwi7G7D//wwQXJF6L5M9NkGuBAf07uKDB
D/585HLYYhMP8A4EsCmKfoAEf2noWszCRFFO7zja+NND5tnwiHEZHvVYjcFAMV+tePW7y7LuDM1a
bxJBHrk/m/b3JDDL9DXBcNM6uH1lMcLx16X4mHodurXBrKssZhbEFGeyLPlZsmhl2HeGi1TaWhoX
safXq2gqHenuDULy+qdWS4Iwt0urudc8ZmwHeBouxaMijOCwbhFinLsd2eiosPUywtjbraKg1Dxn
a2KmmOhGHxNOo+3uNTML/CgztcWI9S7vpzDTc4UBV55IGwSv1Z4zd+kIdq5E0h9G3E7erXrIYGe5
Zt5dhSG6V98sXOMyqiU4JFmvhsid66DitCjxcZiSvIX0KCmzdwJX8zJuEXuYtC7ZTdKntklTOi+P
s95WSWipdnnVzEZPY4V9kPa0Ir0v9rkzBe55UfO87MoiFx+E4bY72PpiPmQ11KAQTSr3sYcGBEln
VJ1646fxSpetmuYPWdC4GpxwSM/7HqGuiPSs0R/zqjOc220QvOytkTSJeFpJpA67IeleR7xsmW5O
Q00dskz9t67KEu8pq2ti0oEd2/XoS51zOJ/V/OrUoiz3GUTTNGpVmtEuWYwC936n0fE7nZGm4So4
F4igJp7amSccImXteddUt2AYems3iTjJBd9izM32tZFdBpN0TkxcZ3yniRqIBed2XFfAHOLPcQkK
aKSQIE6qu46Z1W7H68AME/+ErtpZzkQWbEn6MJNWvVrPntkJK6z00v/E/JIR3jTZzIctjAI+ZrWX
kHRtt4W9cwBxBkwABtrHKa+r7nUWVf7ewOemk6jt1PjWUDoR74KhBObjjaZEaNb2ZxzmeEjAUjNO
5nhe+9G4eRPshkHmXQwblPxOvXHS7Ll1ivmLSV9lho2pj6ykcqVuFUXS4rFFhWjerQxPXPIYDT7M
Fs2wGGG/1OmwY/bTMwhGJ8d74U+rywGruoHoI3v2jX0dBOq+DjpszzA0mLSn0qZHOfkaVonxiIIE
q9Cq4kPlgjVVbPRK3StTLxY7+nMpjrTrAgeGfOIjWqce1JtqEiZ5hDSu+ZYSbymYkaPVZNU3uyCT
aybGXCrKDK0QTYO1gZMFwYvKGlfZsXAVvxhBU/vqD8VoktFa4fT+5+u6ml3ifJJEimQxdrVsDX++
dP2MjncP0Uuf4LauJPpkSOlZHYSejFE++J89O4XDZQsNTlo/pc4nQO3GPdX2nJthuniAFk4+PHBP
LBGKbLFftTEpbpzSG+9cY9a6TQNvf1HabI8E+Dbf8qLUjwhU8gtMrH43DabDmLthKUO/ZCbum9Mx
rer3VKo+XmsG+ntXq4qrV24iRRsKZ7bPm14u4ZSMqP5X3ZlpvRL9o5oMGTplYe7yNV9eVet718bT
6+eAAQNx6mnavM2lHlzKRQgLW4MaEp0spBnJOqGjbJryRU/a4NQ5c4OtxUIpTjxJfm/NYytRw1Jz
p0CxXqgWL3sulfPkE2Ji8KQE9ha2jpXBA32JlHHAJ7hhn3q5yf0ZvIVfIYVBrArJpji64s86JKZY
o4IAA8p7cKu4JYXlsSD1kwwZSuF7srSbG8NveQYERH2QKuiiAazqvHgKLKH3ZROiN3Hi1OnF49Jm
heIe+svdWsvuJp2bYoe/3sJ2PD4X3phfF3N51/O5/+gbDY5zKzFJeLCwz2qnqWqSj6rIn+Tap6ex
k/0N376MJ1/KVwU7HcacSE5FMBdRW8rm0Ba8uhNDoyH2wLjOq82CFtPWRmnKN6KmDeByUj2xcokq
6uYdiaMlu1mZvUt8Fp7YsfGEhuzu1mHeDt1BDzbMpvWq7G4OyBPYzV3X750UWx72CxfRSsaZYFLF
VjnTMxs6HpIk+RX4G+rg6jGqiINuSj43a2AdDcKZ32TVN1T2mtd9EULDpZ7MsuWpmzsXMJG+KCyp
8YoYt4PRjwI7N3e4ibnXtSyLEzMG/8BOIm+qufCierDTM+14dyxrb32boA5HOOnJat9lLf0YlrDN
F45GpOgF/sxH3BfHY4WBSJyumYHy2K9tkyRMeAfHssq1JpwkTyxUYzF90xplf3ez6T3R1/4W8CGN
R0qR58UOkldfL7w3zScqL7aH9stInjqe0ItIol5P/IqYzcmIifZ0+FVF4F3yvM2Di15O3aPNcC7G
70SJGIVB+33Rx+Hdz4funh2+6zDlM50rtlvjV/j03pPMJpI3ZhIjwgatz42s7bWN+9LEDyMx/QcG
rd7nql+6h1xzxSMbZrXD12X9WBizcxn9zGC3aRNwuGL9Ouir8VGuabE3h2F8wGUwAFEcg7DWlyau
wJOn1zERNfuHF/QD8p5s/bBWOLZELY5P/W4c+nY6FnCogteGiiwNzVJjUIkmHWCDmCa8IXS8Pm4h
ILivRbGy2M11CsLVcup5p9Em9FGQyvLdH2cbst7cDi9+D503ZDvwSwRZ68p5kqwNsVqjua+zapKR
OW4EhnzmJUIkikHjnv5YqT2nQfGR1OjJ3Y/FyhyN3HMvbvWgPAzj4CMxZcpaI4BoRv1haTAzxQzN
+U5kW3NeMzb3EFRHuREWIuV6yFACZNFqLqICT7CkLUPFM/Cfp8BYoHXUstJz9FnkTIRp7vifzI6L
juAnk0ZTbQKQY2LaaRlrA5kcO4ogVFI2i+uHCiSIm6TWvpueRJo3+6lI4rRcgilyNLOLp0CN+1kl
6Rpl7YR/TL+07N2G5m3jQGlWKJEhZd+0ToOcvEj6QcZDZ7ra4+wJTMybKfDorTg3YUO4BmlgjbCN
N2l5i7qXJF9F1WLb7cERlEKcATqGJvU8MTvu16mV9y6VkrgxEmVgDZUs5nhOHXT6PAnC7W8CXKs+
CcxzHjiR/elsC8YQyNgwow21UnByLX3bfpP4oZcHvYECfCiULZu9R/9XxiUE66OVz1V6oEPXQzsL
vJbgbh8/o3l2XCzTLZ2q1U5y13goO7s0yM2apntn9iok0JnRHqRVBJeqlYG/MynwhljWs35cEAIF
bCbCvSxJ6+iRKFR+tFDNP5pYOmax3drOO8XR1a1y7Jq6wey8s2ENKgk9d60nErsD9Gps+Fq11xIs
vOeisS7V4Lf2QZdYN0Ulfrj2pakU77+m+1MRBtqMPDyjznj1WpJiQnudu2vBGQq7QjUPjC2qPNYl
CUXA3DpFB3mhaowT4sAxD9bsBUY9ph0cw/Q9+AMNFOsrZcBnWv7xqSRejRJ8QFTTG9L9nhresEcB
ukSJQ7W1U7mrXYuyat8CIw1wv8pKfj7ppAu71W7JABLjlBdYUtdywFSoXUxoECDVYTbAzzzWdSOn
cJ6E5YdONSODrrBO7OB5ILsI5epoNziX+R0J8o5mnGl8RmJkLSlegilnjJQGtf9pxkQ3Fo69IDlE
LfnSWdjactGbp9ToBu0pnzImT63vt1FQeSzf3q25zMxqzBe/zeuboFbc/8UaHcKGZO7duJMT9LtU
l/azNRbNKyDwdCiws3qzhUUxD6lPfTNHo3vwu6ZY+MZZYp+k5lqn2rSG+YSNEXxDR0r9LRlSYvHm
H01AVhrKvFmK4iVPLRhBPWLLFRPALfh49GcEYQTWZxqtSoLx5mwk75Yzi4sudHXi/PdPsLLHm2Co
wW07RhltXGXWasUy0PDTp/obomw1rfVjZvTrizQWacPKluuTN/XesMuCyrqUDlwQ00oaAgSU8u8x
3wKTqkuEzfq2WThGb5lRY0/DsTfT/onym9Ejyx/3yFkc22RrCLMGVJUbX9wizm1OQ6b1u9bzslPW
Zt8cdyTdCNTqxKKbjaj0cc5GhVXxkEmqO2YiKfaa32YPtnDy7z1Kn3c5OdpjFYj+LcC1/CldmHIB
bFqx6TE5i5x69ZEo9LV377J8vyezIqS1pWX5RFpcjVV3tmYWTtRz2R2QPXivRt9YU+wO2ElpW//l
z4bLfzd+t9xNZpBFcObHvV94BEAEhKkj0SXkL7JqazpOpl2fl1GoA4cl2BU9pV964NWJlRK75OpY
U1N5HIAxPgrPS58NzXQvZm+zWWwMn7VSR6q35Q6Jp/nJaed2Datuzi5GM8APozjpD8gx63tTQ/Ab
8rYDUilbyZPCr22/RU89q9LwYP9QwDM33TeVM90NOJjBlxosRtql961Rhob+AAkvSzRYq4tfi/w4
TitrJEklMcuBMP2zaJR54vT5DvU0/YbsdzouGFjufDbVOg4a8qj03OutGPcZIvpGJw+MaCxHyDFV
Wt5Wvqx2cysCtoiWt5OzPqhJaicEcz8vufupEQHebUOax1ZrUNrqlh9VNH5Rl0/9fSVEvcusebqd
1/K7QxjYfiKu8NS7Vnmxc808Tgl5Fhxo9q4jDPq7n2OwKbyhuwvKwV2p8Jre2ed9NTmHDBvdq90M
A/ZMSXHwWkM791qalrsBmXeoSS9DsDKlOsDK2EFJK4niAoytqK8T+DtR7jf5WR+T6cEc6s9r2qoz
5cV4LBa3vymlp8Ph9+07sxrKFzJLpm6n/F5wNnPQf5whbhwyJxkoL8xxjDD/EfPeKgXvEu/nKcEJ
3zqqeg6+2LVoHutBH3n4VgKZqM/K8WLMZaKFs+h0prNmPr2XfUfjYlDVsE/CgQr7VhSHWXOXL95s
l3dD27by7LjOdD94GosoM9fNDWTN+2+6YqwMPDeuFLOj9REmIh5rvTTqQ+F56ktS1L4R5lQdrF5U
g1pYaTQovMYrNXlPQls4KyGfbL8isINCPY8yKCuRhaHZzImoO7vWqjN7N0ig6S4xX+2uMy513sDA
InJ373Rz7u6Vpr3pSvcO5sQI2chzdckSLT0p+o+wGLV2R43C2YpX5xT6hZGcOvJ/shDzy+WIdNJ4
VqOHqox9gTBYd+SaFSbLH1u/xlpuVAHw6BQU96lqujcnxZeD7nxoPixY0/UD7LZSuV5/mnsS4PZe
gT7xQ19P0Bi8QOpjRLrPfC/sSUvuFmfywQym4KXWcTSAZzwfiEEv1r1KZ9ulW9GXuFN5+Ug9uO6R
8CIH8gyn/1I4df8ZYLpnYtZNX9VMTAs+pusOp7DyMOHUf6Dy1AiRC2b7rDCv2w3VpF05ALsv0tCK
+8xJO5ToU0MLhoXbrUnrj5HT0ienuSyJ7KZJeiBpEyir9AFgyTz4Aq+yXSKO3gBworoUoA4hZI0M
bKRio5BrdvQaZigzxTrkbiLIvvdAveTNejRt8egtkhrA1foR3Zq7PnjrJD91zoIphzSH8R5+5bJv
svGN47h6yv1aAYBX5X21ZCfJt4V7J1novlvI7/aMEfR5zcdVP6eev2HbldLe8PXrPvnVeG1zs9o1
DD+JKfbEJ5HW+mPf51XkIKpigKaLV+I/2iOOjswLPe2JEFKFUVdfLUdq5mBhjKFRbdMnA/LNcBkm
uRYn2sn6YPWJ+6ZVCPwKKCq3OU9pbCZSm0Zy1VSYrU59YtYzxjPxTieZ2drjQD7HiZrHYSlYj4Yn
5ZmhXxplHFP7XtPs28Qel5tGeBo5IetYd2EwWF4BxGfg5eE5Ulz1PjBeE0llN2OGCEem0JpL0EyK
2Vxbv3mZRQ1XLu8G0tx9Z5bixSzR/yRaIvC9BA5VQdbfFunqXmGtPq8a1T/Y2jcPS5QPzjCwgoZq
qO/KYA7tWQ0vo11n4kbz6/FlsB3t3NX++IqEF9tJxyoa8z6njlBvteOnDGE9qcM6TWQuY/ohl3HX
LFKDNMUKr8s9o766uychkmGqV3LyxJneDR+8ikTs0OppX+CHMQlKbKF3h8yaGFx2VkqVCnte10KB
ZcvzQr5Q3OFOXoZpNtkXrdb5CzT27v1iz9UHTtweDkYtqKWauUmBkcqU8cBEM1LFRtt37WUcmyRD
/EBRFWZ+MQvU6YZqb6hMAgyAx55tRtkeTRfP1Gf4lFXF9BsK0t9NzB2sXikoIUAh9PsZ++kaO5nh
9nwHyF7OfiV15wgbJSsIgsQyDgPvpInNpF+uXqG1n/6CLPyN/OUXCjzTevxJfoRPk43nwR/8+Xf7
7jR0RrOSCDjUtyKw5CFdjDxeGbrGwujksbFK+aglhV1FufytT84vfi7Q0hAlYZW3ZdUR0OT96rI/
+xJnyk4QUFSSNcGMS5vXI5lSrhUhBnUPNOBMLNG+YKfsYSwjY+VOq2RUsGw9tkxKinpV8SdmspXE
dkmLADlE+P1OOKAPUcMmhr2g7lVtHFRz9jvvtH/+CngWIXkga2Y7e1FJ/3wLM8/JNOUyDF91AxZq
pdeQBrNAiOVrUtnO9KH1bSzvMj3gLcKeVf+S57k97HuPAe1u7gmhjGhbuhx7FKGKUyK1pbxAh0tI
Lc7MSovtYujUfbOSuBPCN7G038hjfolz5ylQOpFfA6q00cTwvf/5K2BOZjCPt8vQNJLCPWR9xigf
5oSpI+JkwLgbC8PYuN4FzyirfW5uWhrbrYcP8WIPRVUdVvz/EHT+eApap7nlb8Qaf3eRm1EUqPfG
E+Q6f75Iy+K88JKuDN22z6dDYmluc6lwODp41B4PYzaL70ExAjfl4Jhf/nwrggYeI1FLqenusjwV
TKy8PsOVZnHW4Dfr+EfYz1/odtBvsT3GRgX1DxYEZDn8fIUkyK9lkGFMY9ol74BVkAz0VqYdaLG2
sMI/Vx13LZ415Ee3qWmmZOY2ZpZfUUQ12QX+XkoyetkmAFpmJso9WNiAbZwzoON1eixV23yDhRgJ
wCKax8V8cZzE7cOgL7Hi8Ye8sPcdBbSKcc9rt5FO5x/I4K0aPrDS3mmd8kdszhi6ig7wJFKrr31u
s9mft8gm90OgLAeMfRzb5nfv2LYMfr45eA3RbG3kH0xP/E2j9RdcEOAia5OuEOFIBOn0+OemOhCP
omBmMYO8ci44w94V4DGx1/SLe0rVsJbXoM6UIjVuGQ2mH6qgPCw72MT8u8UySjq4GZdKdNaMxGMe
Xf83DhrmL4wlHitCakKtsCveXK3/icoNtlJ54FLhxJVkV+L56M7kKNYEtqJqmh1JfTaMtX6kJ+yF
MJfLGrhpcXb0mn+36TvvADAGcQhqIFoyzRxs99kZi/yiu4tv7ys4U1oIsmsOcVdI0CcCCvhRU/mN
oMir9WCO/V7m/ufWrYqVkA4v/wRGoS+/oT38fB5g8ABlnW0EszticdiWfnlK2Wwsi11g6Vv5c701
AWlUQFs5VXrVnl1S46NUb1zKIXs0d4sWVL9Lm/qRYPR/3xOugJuMMooISCy+CKHcTsu/vCcrWcBL
nQ+MxDNicfduatjUwavPWORPVIrb7NmnILGzT1uihSLzqt92ViM1vzqZ0+Ly3DrCjk3my0lkloxb
95U1y7c65xyngU6SkzbNSbdD0G4fHImHRNzRr+NgQ2pxNYV4tWg7Bz5UdfjXp+0PE4S/fjkQ9s10
Bw4wogCcGcyfv5yDC6SeuOM3mqvulmFRXUamLLl6hhzBLY2wTEKBHcg58Yrsc6vXTEQ9Ep+SHQS3
hNzToB7Ba/BhuFsY7sbTkudPplLjAixmOE+BXPKLKzHUueqJg+IFAKruY+SWxq1Qvhcx1Wby7y9W
Do20rmXLONIZdlXQ9o92Qj/3GwreL/xuaPa00/rmX4DqGMr9DzOyvzzOUmu80mnKb6O1QYMWwA1t
ULPZ0EywEurIZ3o27XnHmttySpU4OA2jY9oKOrMRSrr6DfPlF37CdkHYjxM0ha0CNgUYAP38CDBt
EdRBy7ZXcJyfGtlqT3ke1F6YokLsIC67y/OEyxFg9FgmYjc7aONugqAWgoHZOKCtAWvH9Dp1gvc6
8/Nxl1e6e/WsAosW2RbVey8c0Fan7apbOdVd+aTPvqJF3DBaNpr21WwH54MjgRygxhFAQNwAf6pN
TgveoE+aFy0pbNc41fyi3A+JxivSjB36lmmgA3UGCIEY6hOkjdYSd+NoBolPo2S1hDhUjRp4o6ea
gWNJX5HxkbO9RBW7yPgpwO4iCaGKMYo2K9vCss2T3dHCN3nvw1ygF8aGP9k1Pk05SG3SqJ2Vl10T
114V2CcyeDe2gGbCdS1b43kIFj7JaWjf4Dz3XhlOVXBb6q2LT5RplMHOGisqcKcsXQA/7q4WLoYE
Mfuxtv4tNtH/bzwhk/3hX/CE8Ej4/BNPaPv7/+AJmX/gZsY5u1n9Yd6zGWDM34fxP//Dcv7wLAix
m2zSJX1oq2f/QROyvD+QJ5BswU/iAkgV89/2ARafZxDMy46IH9vmWvbv0YR+7HR/3QkdSmX6fHhK
eIxvRgc/L8NBwozIR81E867hELtaxQq9MdGt78SjMdCFO2ICpYnBrD4DhtIE2EMu95af5s2+hDCP
9SDoMfnzbkEYhjX6ldrx5ssxKijBK1ggXAAQBQwaSNat/9UnyD3Zq76Y1xaWzehr50BqAkV25kzC
OVkcF8/sGkUQq6nXwYzH1W8Zf8LN87KwkbqLXSBRGkYndosxdvVXF5SWmrztfSbXe2MMxrq+UizY
8gn1kCIq2F/GzcdvRDLBBjM2afVuQdydLBSbYMSdtEZ1rEpPDo8q6cYSo5bMseKu77dE2GAsFJiM
ISc/BdmTqrhlKNrr97A0ki+5hxycXA1KS4YVklD58aUrK1mf3Fp15mEZPUYWRp4YZkTJ1cNk0qS/
AsJU2pK/palaPpS5O9x10kZsmBiROav06NVG9nXQ3Jcmsa4jQz22ZefGLMcDWxXNlvVdigw/S9C0
aNj8ZIDrm7DuDD0EH63Y0ZtbzazmZ3Ix+rDzh57Nk3mu04AXV4F2w2V9pKHknoq2uwUxOk95eknH
8bOar0ub7us6uxSVGxedJyOd/LWTaHOGj3bmYVji3AQpCTsm2oZy2a2jzZiJ1JCBlnEt2pdl7W5b
7rB5q1VNd557Yt6XzJ7iBRJy6M3ZA84V+T4t1xwy1CjPSg3XNTGd/eBhlJOAiexshUfZajfq6maO
fZWTcaOPGGTyYiTecswK52nmIrfcgxeUh9axz7TioTInC/71BK8kSI7p3PeHSi0pI1oIBaZtP49a
D5aXe1RXZpYcppYwqG5MzmUO7D4tg3lbKJRpR5FY+o2X1k/0QZQx1UtbwAIOgg63iF46AvmrarvI
R5PwTCZ3c3bdPqAz7Hwos2l20YPvruencU0tW4W2WEtcJfsbyCwR+RqRpWvmbk7O7PBXBpa5s2tg
pX5oUhhdu1ZPGR4a84QzKS8ChWh7FE7/KOyVDtzDz29C5Cs8aN/APGWYr811snTqiDGIsxw7JRK+
jo67PE5dc/RawdyLAdaBNK5nA4uNKtXGsMLx577vgXWayrAjI3N5F8RmHu1Y/cmBXkvGRrXI25Ip
KH+4nLNSrpeEscB+kPzDGzyHE9F176WW5NpJ74wrhV2NPjjNmciK9gt1TmzWnfjSqwJnmyDLv3mt
LFpK1/XzMOBGN86tijeD6bMICnFBC4xATsyAroUCRrJoNfEVHcAfVzOLlsRuw7XFXGqoJdh3Zd3m
DBRDN9eSW2bQAafp4sR8q+DexHNp2gW54ZI5MajPhVF+my2j3rdjZVwx9Cpr4s80JnxTaxzyslYC
JTY/3UGSjudZ13azpqXmGZhxTA+rm0GzZpYQzvV4ys0RwpA0jXRvWvlgYSveEcc5OSy2Wkp2At/s
fJhUiwWvsUgneTNjdl7dVZ32bmjybsjadzdxzQHBCYjg/dKMHwY1+XGWqQ+FRw1oyBVFwfiMT2oZ
+ey1N0zez2lvf1q8utS+VLjqwuH0Q7hUp9zYxL6+Du5uJLX1dWBEF+pz7V+V1ge39BtX0bAVFiIo
wV4b7Z606HMv2ivRJ5i35w3cw9K+K5HZoAvQ4EAtpITDRkKjD8UySlF7R61lvDPbD2JktUVoTR3D
5Cp57zPvDS/ynTUB/gdWAa6qt/6e6fvHBG6FUejaSY3V+mzWJDnpSdCBtlrXBuOmDSTEJg1FVFV8
bhKtvkvrOY0Np4JuYtcYZ8Cc0qbrwmAd+l3hj/vJ04y9Jg3eLNnA2itQn7fCgdrBQBU6W8+sc74Y
+Xo72BM4GtAPzFKlfzQ68hbtABjywUg75wKBFm9bfhDbz+bJ21xDVp3/GI6FA8a7JTVTHM7RPOgH
fJmcK1j9eEKbPcSum/nzsYWBGrqz9o4JOzGfUNxWZLzoZYcKOZL3lFjZK/zETx6F2c0SvDBCxuu6
22/D/3Aohxvc8WGErScZuPJTBf1sAyROdX/jrCcVQO8pu7uCnpudY+giC0nC2nQvaa+PF6xLfXKF
/GCXme1FDfC2pPjKTifB13GQUszKHi1lp9+s6XuJbs1iVZshhhrFvWBzICrnAYfI0DHUYePaYSSS
xTr2EWLF4qCkGX5zhu5xCeqbMrOQJn9uR2e6gaLEpL4/9mty13XDrd7I4UjKRBK5DUE9tpE1X+DL
3LWec54z47YajfOSlw+FedI1tVc4lHbJ2WCkqqyaOqBh5jzfYrl5w8gTgMLQnsmkubqtdteRCoRg
uz9VZvqdzXdOT15Cs2I62Z0Qdrnvg/zG195b40E2HCpDuac4+EgGpkYiVd6GYJC7oCUb2AMvsytR
4vnbFV9b9smm/WBaXwjNDKfMJiLum8QWgTHCHbXBnhDXSO9vE+h9CsinRdYgYH701PyBHBm3pRGT
ecwYBLDEtdeeEG187ORJmDkG46wAzC/SlUmyFvVtGSFkjKXq9mU+H6taXhEA2f7bOghEQahQXM52
l4BYHwTAvmXJ3lNPRiUzPthJx27tYAXMHANsxiKPwUcOqZjOg6mOMAtQSX4te+fOF9Z9VjW7ogNW
xdLFC1rqi1eYEZVFxJMBwZSSQDJSDm4rue2KH4vSi93KgOyyM+1v8F3Zp0xxLyf0qCI9q6bNyXJy
SSC0oPwMO1/rboISzWOSzhOz/DEgJHDAwyxDwGOY+8yk/lDBXesnEbPIo3TvuyHLsdVo4OiQmX0L
jcMJu5nkMVy624ccLJMpHVVzNDs9ZtQgPQg94N3pSXVarQMjiI2IgoP5AFDA21IuX9smnc6zLCHc
JcysfOduVhnk7g79EA+75RjGKuJh7TTz5NhzfW40RxzThbrUl3satOEWUh1rvx4/DYttnfIWWC10
vRU+mJuI/sGcBZbAd/9F3ZksR45dW/aL8AzdRTMF4D2d7uzJmMAYDdE3Fz3ut71Z/VgtT+mVZaRK
SqthDSRTSoqg0x0OnLvP3mtDu24gExgyGqW6mF5/MrrpZA6b7hbsMd2G01RRcdDSm+JRWFX7ulj+
tHcSPoHCnVr/5jHETvXlrsUVl+8h4Y8Esw0joKqeEiaRcBVi3HNAzCh0NrZV0Z068ALB3K53np4+
EbTRI0QqpBXrUJa7ZsiJhdr0pvGvEJjku13PZEXnnqvbjpMM6gBjT64vduiZ6WdqOgfXzd9wYjMe
ztZTvKabNPN31BYGq9sfsHo9m/zkustwAzv6Lje9VztjO78OVBma9/bwIM3bFU8jYzta26x2Q57F
qBwZFYHrnZHpRDgT3hgk1PyQuhruiymEw7nPsmbdqmTYxAzHKzlUf+ZizZZ96egR/p8B4DH54KqO
0rjatpr+bmXMmosRxWv7VNnNPXt0lvWu9dLr3dvtTzkdztqleMpy7dutSMedhkfN0L8GbXrB7JmD
NcH44MdTONBrFgxMUhc110/tGpMazLfVIs96aRw1qzriQeNZr3OUX8wnw+5fFr2OrOZ7X/L1cm3e
DsCTeulwBTjfjH758Mf5w+vcczLqG3xYrOIXf6uZ5Fyz9gXH9b09ij3rAmebj2QJ2q4Wm2TQrZfZ
FSp0HC3eCE+s/FkgGEJfKOvA1g9kuzyYmQ1bXYU6QB8ZJC2EjioRfJAKJwxpcA4FpImXZWf7/rdh
yrpTai5yH3cYvpno5S1ksGabcZCbwSofkvjo19aHFy+ngmtlWJJNFaeMSKnOizVJhXU+3mfvmNTU
tFUteoa/7FlmbkhwfygP25WgTnNft/qnqVvRYmZ4k/Hpc3fMcSnYYH3S/isdiBq7Df1B/qfba89+
7D4n5bRzGiOoq/K2VF6+i+IEFBPDG9YG1hopBX/+xclv0rhfRbGlTrfe40QJcdRmhFhnYbq2RbsH
kc5dyGJS3qf0lcnAEu/6rO/8dt2YZrV1ZxrFKLFlFb4+Zm52MEDs4JAkosHpgUmFu8xG9s23snA2
LU/2Wc83pounYZpCT4CAiYkoqgt47cC138nmIJB84X/YjKp+yFYi8O0YNE3H8DdEC++RXZPEHoOq
pixKMBnHM1NVoj8o09kLAbiSpxscWLSaIdKr/FtTdmeCqK8Avtx6eZIiPffE7ozkc2aejAifbLEJ
n4t0ivJhfqWnBm9yydMDklHx3K6UHYZWpwxyk/d5nyIrZdqXYy0bk304DgVFaCFZT46xCAyLKecq
Di+y/FEkvj1CZWWVh++j4YSD9xJDHU6y/M0dCfJtPHthFh9VE/+g7hqjbuKNi3pkc4QXojUSJwbq
07OSjytj/spZbhClxCNxxB1NRjY2Muczbbvqm4+/GatPOVRfactiOmqsOLurKstfn2xavaxAT9ZV
ntPZzw8WRoUu0pIVy9vkC0nVnq7lCO5VYVww3ScoUsLonTB3rK4JGbO6T51DImNeCoWWnmsS/xiZ
YiKYTTmtt7NWksw8tKr0W8l6hVOJ3elHS6wThJ3xD3dhaVKFjVlZw08qxyHZutboEuuIl63rdHQR
4togdWymxr3jLM2bpVbrPJqp/s2SWMkJ2+oc+ilZwH29aOvabeSCU6ljSo6s1B5wjFUCk342lg1b
LU2jBrCtMALUGkkE0uxayXg1kYyONEs4L0mvcJJy30/uBfjYGoOIwQyIutm9Y9iAkFR1JbtwLOPw
UQuyPnfKm29WTHDo97yw+TnRxvZuxhNWBLmEllRhLZtw1tfFc760xXMhffGicDp9aQJyLVWZHV2E
RlrTYUGbFsydsr8dLeZF5/kqSpHXWxysTHBmQwI5II9KZYeUrkxhsotqxBvQMZGA8cb7IIfOeYzR
9p+9XE3cWtYJErXRipnMde9XeHQWVzjb3qnnjm+dqoqNperFi4STCYJnBOMvGHtLvv7j6F48iaMu
qNsGJJeee2aoMGI0YbHwtAxtby1vN/JZDEECSPfJGNibMhP4gi1c1igV9N6UfGZFpb0aVGclu9It
Mv1pnkV2u+3Z+sdMoIXcKMjblZ2f+gETgcjsRBsMjC5Dr7Vwve21/6G4/z/poP82DPlbZPL/O7bq
beH67+XQ5//1312Rrb9+U0Rvf+Sfiqj9Xx7mCoz6ro7P4A9s6j8UUVOARoW0SuT11gXuOqwE/ic4
af4XOzD+J7RQ5qI/ByfRUb3bFtp1BUBP24PQ+j+Jzn/6LiDS/lva6e87RhfzAAUxtz5EsHRQGOy/
rI45e9EKDtU+LNqcUs35bir9U8VZDfcOGvD/eVf+L5aPfwAG/6y93n6Yx1/G7+PyRvy1LagYe5Pz
oGBaabRKPVV5a7THvjawvY1Dw3PQbBfTOKfCz7861dXeDhcvXBejH709N14qiNOKfp4AzFbcPmie
HMWhoJerv9KpQD0t7sIh3eKtIpoj+8qhUlXGg9w77uyeoVzI5lKkg3kn+mxI7us0z/iG+N0iT6lY
E7lVtsnia6qAzUXmoFgZGRoUYrTMTnHQuNXFL115+0PCJFMHqs8qdsM4DNdsQPHeTlZRW8cRwDie
9FoC+bKhKpRha04Xjqn8TQOGasJDbdVi/PIcyfleWVpIiZbkUDbdHID52FvXvEm8W6JjFugdneJs
I/kLwtlkWbX1Gywf0aTnDOTAHlLtPC+LfkA8bwiiDDNxwFDpdiF3NbMJnjG0gtqOypGDBzOWA2rN
9Il+ETgYhc/0neGh93rD73aparIhIH+m3/AFfIhsh3PfZfOD5DhTkFsfVDPZb7mWo91OifY9yQFc
G9pDOwknIhfEMb8aVjqCQaDMWWwE5OOwyNpaH4C35G8q4jpqNX7i5Lm7bEb11Gq80EY/RGO6JAFK
673fuo+Jk1JlGg+v/u3GPyxOutFS8z0d3WdnzR9bMzvTPIUcbxY/hebj3BqL6aDMHCOkyrdc8Vgq
IRj4FZIdCVIR9ApHbsGPDvJMHjNnPJK6yMgDmOj7Osswa9g1FQ5dDlAhbrwLgJ79NKmZckDS6j0b
zaKYHxaZn5SOWpOCE+8Re3EE8FjL4LwCVvciyec8V7Au9P6XMZv5ZtaZnpa431eqMs/mIh7tmyq0
msln2sN2cJNz67EMLnqc2FLF1c6o+y0EpKs3lVEOnj7KDe2eiWGrvO6RBOt9ge1lXxrmkZr4IKbv
OdBdNoQsws6UnOxx+iNa1OvOnde9WuuLofjpbePcNQ6ZDTOleYgy5rTrnrtxerIY8ZmA71erhHU1
xi/WMJ10O95rdk6j10006VXMATXPD15Jj7fpZhEpHJQtnMi8pixshjljVbAS3lMv7OuIURL7SNwF
ZsSg6IP2NAeBswIoyNcjKuv0ze4YgDR/vEze2sCm0DCU6HrkpykBDP+noSEHJT6kskzm+Iv7X/1i
cviMJzeYgQRYJlz8kqFQGWBCiv7cGtUzS5mUMK9/mk11R3nztQH7GxAcvzl375cY4yZqKeKCjmWl
qvM6jNtm2cZWUwWeabyarY+R1mO776t+50FTwbT/zgu9Mz1+FX/Qf/ga+xPSyVeVpV8qGZ/GWcOB
6k/Q/pxTXY7vzKz7wcJAYdeY8TPRf087UkQUg7FIIh2GwQ4a+tpZkIzMExV/eqRuZP8KOXyTFnl+
Htpba5WDENg2NkeA9qo0wPtVKn+OrJaQb9DJJ6n2o3ZbQqU0SVnOtmq85oRs+NgawxKmCyggUzA3
2BIb/4hCTOeAuqP0skMxaVRoWTCkVgvUrfS/q2INp0Hjd41ZB6ziEPtA2uJahF3Z/sLMbkALJexA
AeNW2CN+RSbZqcIEjvIcYfbOArLjl0lZ/DdDdupTvd2h826tCiP46rIjgIK0VTmdgWl1pFfkkMTF
Sc+hvRT+sNGn+KEv2AgpyVfVdKsHGp4p6mSECicB1p9I22viIayY7pSGeJE9XAWkqavFeYob92qK
wrvGrunC5KrJsjbus210/j710O215RVMJuUJidznKS7nWR5WxU+zOlwlZgFaR0sN9ch6yAlU0p9Z
WPm7rMArnyxVuZuH+mst69fGcX8Sht9hqEmZM1OG9HS08P6noLlE9kOVHFFrj44EbKRhXYzDJpHm
1uYf7/ReAqeyp/xQT9px8VZeaTr0fZjIQn9NObLuR5ee6AS5w+IsZOfxAz065KK6H1JwoTcTCcMs
FRufisKqF1ngerEe6mv2zI6dIDK1FA4onRByDmcNjlG99DaM8C7IJxwNPCTqey76ZoN03hnnpVR+
aMy9dtGtqo98iD2BVeYcPVtCnjjwtqXTH11fW5DEgDLRnHBC8jxKXPEhA/KXNaNRBkZR8FxMzHKT
ecbABoBYu1dj1M1r/SQ8VPnMjiG7NUu6N2sQYGX3YZvAhSrjebDgblWNu+ss3ZlDpdw3MlvWrz6v
tHvW+MQS5/Lsls25TkfWNtTvhRDKtl4vv/tt+mzOjf1rrW6ykSMvrjOuD6jH5W6xsi0Pv+/Kpb++
5RbtV3I95JpO/q9cIhG3+3SkXiOvW2/Tzc2hdmiji934+8oqcpbiayJHHpoTwk5up+11Agh3gmlg
QSn3YCsYdfWcxDwxR5baFKuXFm8UH1KtLy+1mxu0rAE17mdsQrBeTbFahMGNs2rKr4oOna0/ggNY
Vus+K/hSVXaPlyGr2ZSqilqdWvCY7cbL6PdQjGAV1hHZ7reaWS1s2967p/mYecEfX2OqrkKnQJWj
r0ZDh4jXo9u1p5HY2UFncCXalZ1yrg1MruxRUzf/qAcgg60u3r219Tkaqm9JW8Gi6r/HtmGRSfC7
s1kJM7Kywr7TWZGH5jJmwWRLLap4vCg48TjEHgDLnz23fhKIsRvOps7tAThvcI/S8eWv5OGhGaBo
6OWT56gPscATWCd7FzclHFxLzzC+azIypmp8kH2bn2xTO7d960fs3z4SvhG4kvTxzvFzshL4SaHR
VxorrfIHJdfNvbFkjyIbCj44Rh6f7fSr8NxtzVloZwOxCBvlfKi6ardYAdztcBNsbwnnQGqrdbFI
APQKlEatAExPOjntgfhPlR6Isl6o5vuc7eXMFW6TewPK4cTldiwTJCTh34/Vyvdk9Ti4DTwlONEz
MrsusOckSmx1Mm4I8aaefjZ6SVTVAO/Loszyi0+nsIAn+Jd8yJ7byY6Akp47mB7oYGgZvgy0OEGg
aND/MqXvVUak3bQeBlXtVtN+XxQbHJcRg0GO26AnvWAp9c/BA+6F2vzKbwvlSy7fp9l80d0BUd2d
T1VnPPtciJWpd0d7dJCEyhmRns6IS1VVXIo+EMSmlx8t3loShrF53/BilgNkO4YyGzjTuPO6hXBa
5uUVjxdPc/HbAxL5lc2mWxzSVE5miPe0ekx0RIgzN2ZCblkhcAtRdyZObYZfaYeFoEbPyC3X3WOV
uLGiOlWQIhqbCeHUQVMO7QTEH8tNnZHQQsjPu56/xP6jwVTv2HL8jYX25jD5k0v0dg5yby1XOFbg
E3mUCf1uC2m7YbpBneBOGg02I7PV7CyYc8JSpPQ8TE+IfmAUciJvROmdive/ZojT+X39PqLVvniC
jjPtNFla70VsptvZNmqWWxUbdOpxvDLyVg05vKBE+JRSXBlUVsFGXlsppCTAJ/TnsWsSqlC06e/K
r3+3wN5+OU6YDgbAm4kZ/t1f3H+yJv5VkowIB6SW1174hLj0cq+xZZJssjT33ZGFp2/+83nvXyx4
8F//4aUUJjYyugl+f09heg1WgoTJmmNiEWXXrfViSaTnLUwPvGCdiY0waAQ+AQCrC9P+snoa4HLH
xTiAT0X7m0/5X98Hn6SDzjXl3tikf1hA/+QJTDDNZE2Z6mFTQREK8slsooZbyx1cL1xsoFCWLkT8
+7uW3N+DFrf33weOxoHdxMZESOsvb8SU+GLSsIWGI1czKPTaOy1Fr51zDqBXrW21s2xcRHyYln9X
5vQv5/s/RAfbxniI2I5u8PtnYJC+Gn0LaEvpzsn3KQGLAXgPWEUISYSrrXOBAEb/+YP/63fpBtdF
rb61cvkC8/JffuZsLh2GDRt+XKmOoPsAK23G5m8CJH+88j+LCTcnq0kEAsYwVQNAHX//zcRsKTCD
DYGaJ39bRupwwbmz64Pv36ZjvW3e7cB44KHBNgsjVujtuelv//Pv+U882u8vwtHhO/o0T3APFn99
EUUOc8lNmjiEkHfyi+Y5jRm/2mKcIstt4qclRRIsNXFc0uLSVuLQDtx6Ky/r95gYVcCYd3supzUq
I7c5Yvn9cXHTL0cbD0RVke2qIWeAaqziAYonmIK+zJlZ07ehRZr0JLwAm+ifizNcIZ/2iAZibZ5o
PWTh41xJ6UaO0UWO1txTv7kfyrYPiL4dGklPW5vf+saqNRgmj+e1Bc0gZ0S8I9pmbhQUWyb2+Tpa
8TuW5o0vqieKlX4oi0TtLZPEKea+dOa3TixHUfIuI0O/kQz7MNke6VP7FgMuzK36pPG9Q/LPN27L
+XIxJNwUADeL5j8ns8nqh88o1jHjOrvGXg66QcZ1st1T73k/cmoI1NCV4UyegfA6+vNUIoum1X1r
O9sVvlTvesfK8iJnmTEr6d+wWD+lg/MJvvZuLpL9OtMP2fiQkFj6Caf/oCJgW1vdG+/KczONI7K8
txU+jpg1O1aaeGdCAwSb3KcVLFyT/7OWDGRQxzeynNzBDSLlrdwizu/I4PwoeL6aRobjqZ1+Ye14
5vngBwRQQUTOx5hoCURJcSP3AjBM8Ni3wwaPGgZ39zG1yEEXaTiP1avymyNxX4ImOiXN7YJhGesc
EYUgj4tDQyszO9aPehGHRHEbyeW9ueZvc5LdZuN9Mc3bLJ4+qxlHymg1j1Y2P5V5jKHJ2ui98U1z
3D1ub+ZXPtipVJe+L5/TxDhWtiQyN/WhsifIPZbXNNtE1Zxl8vrDyTScMDkShMOYFrpsaRkoX+ah
lxGKnAxLnavIETqWBBLTzTxcBqt+TkY6WiUExwBrb/mjbgCCdLpxF+fNTpn1yYHqCKyfgjh4C4QD
sztbuUQDMfPGoKNRnXy1kYgWFG7stG5l0V4Mu7ZUd4SVyGhZ/YM2WsN9vbDMgYcMe7I/cSC+aLLn
kl8rb0va5ZhTkMzx9Ogrvmfj6ubb1gcAZUzK3Y1daW0wO2V7snXrpWjaO5AMO+BWCqUinwbMRPm+
BPmIS5Khj0XJwe60Fxt17GDLEUtN3X/l5aRu5+Y3kuHfGpuOCAWGKtSrajiMfNs2GXUfGDSfAahU
4bI6dJTzXuiwbrkfDOG6NgLPUxrWUIvIn4U4Uy68r1HdUG5OQMonGcu+wFzBecgGEkpGZUuom2y/
JMsZu8zObh/vKbAwX9eFTNe6js8sDakIhGJDPL5581oewhKZ7a67WRGamylB3KBR5TB7FpHj8dQv
8gsv4rEeE4n6AohcGqoI3M4++ynlPf34pvXz45x2EJ3Z3LoxwBnXQitr+bbDvbHf2UTJI7irvfLq
GU1CYEzzz22+boAzPOu6tSlJIRKxUVoY8+phSVx0Z7oXS/LB6i0Y8XbgPt0bldi1wM6GHvNPjNao
mvU+G41L7IutyZXSNdln0w7HstM24IujCY1Ck6DAsTvWa3EZ1+w7SewNALl9VtrXxdHJpKtTvxLF
NIDA6X6zk57xMapPI73Rdtr86OcUMWOZKbX0re/0aTfMVEK7MEE4DzUR3jtt08wdJrXWTHhxmdyM
rr8zKueXo9F6woG/1belsbpBlmeE3onG9xsHl/+nW5t5EHcJfo8ur59KNxOP45x3SMK86T73xgQ/
k6FN9QMIpPZe1wAsUFMAlrUvXoFA9Fz8a/Hqu+kctP2y4G8382eDfssrIvLPQTMOiiQ3MooRsZX6
0kZHIApOi4Acmg3zQbFD3MzdcHVb7GPGYulwsxFJjiSkUTrjEiFu8XRwv5wUPOxDrIySQCQT6/hU
qXOb6S/CnIxHMgN9HFSZ+zJm2rjJe7sPyWmb1zrHcR+a/JInr2sYoy13+J4UtjzCVVrPWqxjOSmT
IqaPczWhlQ2XGT1lJ8v+4PjZqZ50O4SANsAJVCpUMaerdXbO2QRrYC61O2/2rsNs2iFB4iRipwbR
A3cH4Yn8WJPVoWyENbwzM1KnRfc69NY7BgK81F1RBMLtTeAmUjtanrwH3PGwTsOdvdaY/sBXND/M
dfhpVQOw7pj4wCQ11OBK4vAEmBQPH74+NTBnbxbEMgUMgOEYERSgBKJzIz/0uW2PE05VI0g9jueP
laEypI6qzC5oVfYvg63Dtjd6WD65tA2qL5xaIC0WKd3zq43LJerVOjaR51nlq5nFl47DCvbSfEjJ
Jbe+UYGtZolPFCzGs5mQEv+WpfaPEaRDtffd2bjHAj1uFy+tI8Ag8TbRECyifOrTfpvpS98HRdGm
Z/QTJyj5d1iH1sPaYitt4phzVze3Tb/hu5xtKJ9BRC09s7msqh/fE1nKe8pRkziSntZHeGbIZy6N
972HzLwpprJ9XGBDHpIsvxMxw4ylL/deOmUA0gSWyZB533+cmC+e6UPujp1ZqjH0h6x6KMaVCzk3
IuABaQQFq7jjYhxwkyw4WNPrOi3uztOaVwhh58WzWJ4ruvlMvc422GXwXKztzsMFHTaZNr+lOIYN
n21qOnMDzKbZeZCSDW0/uf67BoMRgSuL7a8apRVqVmevm9VSob3kF8JXoZ+7G7uV+qaj7x6mAcyc
pjXgSsRr6Ha3ZCPhgb1v1i4S7NCUT4wi2PCk8g7pLMpHv6rTF32FgPfsNwAAA1a1B4ISyxm4hf2G
WUfCS9PjrVmB2fVRunY1njD6ODCDeWa8XHNjJpyv/Hlv+2Mx7KH3WDuODxKEH9CuODLsLAssvs/7
iearTUyjeLAk010N6eydvZgTLWp8AsKqTt2gIUGQLkAfKXzvmfv+pXNnefSEDvCzYcALu0LO9pYR
O995uNlLSz8Vov3krfkAN3OfjyaIEXXoVLvLAYUbSe/esI35VkJCAORtdO6e+Lb3axI3K0qitrkL
Z42ZBzJPN3bxLuG6vD09J2VvLXMqT4vJTbTWgNbBU+pO7Igk1COif1k+NZE9T+pAyeQDgeCed750
iJOK9tq46446OQgngvCyqoy9O/kbepfBGLGkw2ZWNqdxVme+IbD7jBESlJyHAE7EJ09/zHk6ZRKp
9LZZU3wOCR/O4NMQJc352hPRTrEbsxogLDGPvxJHPDqmhiMo7kB655gP5jlE9b4Wnv9D5rRhaflI
d0MmokkA1WYds7JjMvY5ceoORmqoFVyAWjKf9RocST77x1xDTNbS4Sw975oUWpipvtjbE3jCZVrA
3GT0dyWs9Fhq8DTMun2C0wp4i1IvNKq92IljhqztYM/W83MZ1xKDa8Nzty7pTDV8ZggKOqkx6kfz
28wQBraBidKac7VvnIQFYZ5RotBKW/Fe+wLj48zOFfBOyTRA7KQQ3hUrhnV2aZfaEQrT35ErhyOE
mNCuKzdoTb8kHMf8GrCf5OguaSthIbDI0AV54R54F7DC2xI8R+3u58VTIf55/UfXpemE6dgffmY5
5V0aMsllqK2HsrQhbdeeRVLtFkoAu9T2ZbUVlV1/c+b+PC3kIlc/3c1wMB4kmTawjcWL9PPXQWT4
tuIcBKyyL26sd3hpb31L1oplHP2XJAQVXAMpQ30A900Msb804zp91YVsI+4sHzBE3SOED27I+vRe
FzGHBVXg50n4HsW6XPcCHWILN6kN456RdU5YfPUmrlQ7bjzinbhKiIJf19hnraGB0tPJHOLsXh5M
s3Ajw22xiN9Ujrg5KCF3Bfc8pmzW0NWwrXPtVdXuQzN1vN3tNvHH0MEUjP7be7D0jPYx61VYD3B8
dNzkQRynQEsI03wf6IdFxYzJPTS3oYQk9yHFyZ5FgqdeFpaOnTxZ1lQ+rbaYX51pqG8uWjserxPA
WQhyQ61BRi7jjaoZ58cVrdChogslnRs9C1MeluYc3xtzvhknHJQemBJifg/sMakN6i/Y+i5Ll29g
QzyOlHRRRG8ClrPg97qsVLre/+oKD0vZUA9v9qxN4by4ITKefuqWWNuuhCXoXGy1kL44soZ5fbPj
tDXgEnPTJnO1SwYNuzH7Im4tn5NBNLfQzXNj2idjbI4oWj9YZdgbboibDAfjxiMSEcyIk3hbW+A+
syRNsHRXy7ROY88V0Ez5U1k3dxZrz8ozVeA3cxF0AEjMln2am3T3cjC762L7J5/066Nd9rAJamYH
Or8Pk5yvpZNA7+PoJVlFyGAslhHzp/6WrQN3ycQ64CgjohDXRtSZ5qcszRehxeKRzTsDlT3MH66B
Nc3NqDYY6iLhU67e4sokYrEOH42WegELCvsAZPFZW/EbU5/NoI/Ct5mF1wTDSpaMr89B9H4TZmZC
11yOJODEGCnxgusR+qZx73JzD/M0fdcbxkV/qlkVifzOWkFPjoIZex7PPPjMgGsSg0EdQ+lyJotK
XYcvdGZS0+I/Ek34nKT71ZlGH7q5/+Au9DNlEtTx0kCNARB66kVNUH41d5SOFZtSnynvGa6p8k/C
aapDxmwTpD4HotxK1LFsoQ3nU0JBWsadwukG/xdZkGvFJD4q0YXCqD+t3jnBKu2uMAqianJfBx7B
HCmsQ8dK+lD21tGgXANEYOLx5e1e5Wq2AeHs+NH28mvBnulMBbaHiDw3oTWPd5M2ih3xItbyyLdg
a33lnuTcoXen7XF1eEDaa6t4KkMJ6qkK3IMoXffxlDyx3dACG7zPniFkG7fUIlBhqT2QSAdrN1Xv
vmBSnnJa7FbN4velXrNL2WS2M8QBfXoaZIe3Iunvy7L3nieRsyUvVBLhy8goBdJBUc2QNKXdvy79
uOxHb3SO2MQ5U/Vrve8E5Q5QMfZmk323cZX9bGa7IY8j/CNIgu96B8nMb9awTPMPKW1kILf9qKyO
KtiWIH3iaAe3mstNMae4mIv2GdfNrziDqaW4x9LbaH2KrKjD1hsMsAz6fZ/O7sbLcTQsBDBUmx3T
XpoBLQvXMiPZDRI4FIOmbR2b7PG6TOFNeTDt6clbxgvvUBZNTrVfpnHfj+x7UuGcLBMyooDCsJPc
jhG8L/kUN0zYrX9BIIb5rzpceN7LOhpf7BtHSjKbg27a19SY7L1ZZO8lOuCO86+2ycZOsg0jFrEI
06G3pLwSvmLrUipv71eQztqMRaily+9tj1o/DCzMGfXve9u+opDLsG6LSy/bCkI777/QxHfh5vwI
104PylFJKNv2sZjgtWEZKiNj1E91BeewTMcgZQI8giuof5Zlbe4G/gjMpfcR2h+jg3sHkcE7kxl4
KlI0fulxah/79t5cbF4J6L+I7MqLlPrL6rvXpKIGJWssXoi5RKAju9CyzWdDZJex5Qut6cRILPFN
DMxCRH1OrbWs4WxJbBZjdjKWYbECpyg7vjBExUAIXUhy/0xsvjmZ0KK0sFquHkbESuqYjzILkRmO
abB2t2OOJ25WwMlmPo83q+KJsnb+ENn8d0EZr3f92r6kpMgpOKqh1mnP/VS+NXa6510UMIn5D2t5
Xdr6neH34EtOuJw9kBOJvkXA7DquEX+JpDVW9Law0DYG+AayfZrm7qWEI0g2Rz7kWcmY2nanXCZn
S5/3I3y8fVySz0r18RrHxgm8x9nz+8c6L9ug68Wrjcco7DTSMrlevdW6QGktL7lKX1xcyVwA9Kg2
62GJy0/bW17yXCcIiCkrs6p3TPX5q247xA4mfZvyxhDxmXskvaoBmV/c8rL53TISPzGQGfnE7fyg
C/uHXMiHpEMOib6+ZqPLz52AYTgh/BOOGFWOr7toQlM6TaiZNhoaitIioCFOFwfs8jpCCPKJZjH0
fNLgul81UiU9cYztTE6Wf0ScbVr9aWrTV5mqX3y57ZPdlHnEfqLcJKAjQLzFKGTeA1UHTy5Xrm+w
a55dYwK1PuyNMb84N+C1Jro4EIvGOZCdAvMX+3wO9tu0y64cDEnQYtRgYvFAVlUSiakkMdg2m2pw
inc/N2ewV2UTzdyC0oUtvNdpFgU0ldysGgBhTASfQFfvMO9NO46529bED1ERzojqZbpKR1Z4boEk
J9Pj7Il36ePlK23yJtz6bnUjyqm25YK+12T8wdxHojM9i9GZGGpTFgyPdtd9E0uHXxtcGScsxV1x
0UKbjrKBE6wZm1Fai+E4cyvGPLwUjPr61ePoTQpKcGiLb2i78m7VJxJBcG8k8pTVjdCz/zdl57Ub
ObJm61fZmHtuBIMeOPsmM5kpl/Ku6oYoqSR6F4yge/rzsWrOGXM1AzQa6OqSlMokg79Z61tiDh8D
b3khFkDFcKZ+1KUo2c85J+En5B2VeDpWHoStTUGfmGAn6jC7zXASIc7zf4UGOng78GPrpCOp1EwP
tod7QQfIsLyqJ9ysaq9gfr+KNn1uifLZgX288YWTH3JRPruLm3BBNACtfXh5BYG/bF8Zi07nVPS3
3RTe4gK9Fq3l4BvJK0R546ceOAIyUxFvIE6Vy/5xBdsn4e5dQuW76ku8YEPGDnhMBhLVwGod1la8
apenehZKKnaZkzW89IzKQfmMUx7sgDxYB0DtkCU8xA4ue96ZCY2IhovZQmuCCuRBrnAYKjZIZ+E0
T0s/eTws0xCgOw2Bkzdbgo704iScXy2LrJxy/hXl5ALJIZnvRM/0zG1rTjXnPo3wnS0DBLzB5XG3
K2VukRiR/B4VCgjZr/XHXNvWOdA4yIDUxVArrjfIB1PQZnm0k5VZdmSuWxUBJaQx38PPi66ztnJO
TWfBolD53VBgCsXpwPAx57BZAvMMxYILpjIWYsIOG6Wy9qz/uruESxaTsu8TVx6M1J0h+j6ckt0r
ctnh2U/a4X6pRHI/WXYbY28x803io6Ow7dKg8/fNtIPRWGbIuHlicnziKnTYzpBgn0c5BxC1XNt/
eL7BMcDS78YhduCoWsfdse9da5wZCl68yh7zWaz7vnZ/VUW4XIxrmFxQ99Hri/dmTjDFtz5wfTTu
PapTZFn9zg6r32Wd4qPCMLEr/enHWiL/WGHQlTMkQFuaV7QNb3mE2a6gikDUtN03XZfH7M1+w+e3
Y9v0d51PReKs7Iaczk1PtjUHBz3MzAMXCUMK9JG/8uv7Wl9M2fyorNy5FGw6Y9+RYK9skhSlTZud
VdfWuHKIh2ivBHIREJH9Ww9NjkV/G4s0vF4cuV51Vvri0sgfESHGfbk2MetCjS6dst3IuTj1f3Qu
DMeGBBVyQlCCYlUKWWY6rv5IJzoikAFXfVlnfFJlwAnpFHiBGOug2aOoU0TAHYzAvtgE3ofJMCq5
U7pnKhscEE55t9rW3Vl40cQbA6pk8DLeM/uqC3sgS8zCDk6qGHM7CxzppWxKOA6e4gHhgEdpSLhA
soFptJ+aF7/1Jk7fCsD6gddWlUe1YhbznbRv976fs+SxtS3rE6CHuonVgFgZVuW2TfLpzTfngedf
DV5g71O7R/q1jbEze6BtLbuLXna3JMMUNLl+G6+9QskHyRt2s3Pfd6ytOHXIlAyOULmaW2dM1iPY
5z7aQZWoj05HIWQzVhlt+tuArvAA4C0GkHDFDvJttPwPWN1crkHb77s2eoEUxWVFAD0j9Cp9YQhx
R/hWdbugtj2YJerhRcAxs8hCm5G/IczCEyczF16yT0iB2kGR37McS5hAWXJXrf2ljjpGGjWO4OjE
PJyZk1edG88lySQPQJFa+pIYMkqbZEb1PZ1UGz0rh2YF5/sPaxpfo6k5jz6dhU+vxNRiMbiHeb8w
RyzpW5KN7+O00ssxf5/rUBztNXoJnOFp4rrFdU/AbLeNcKN4brg7M2rKdPgJv1aw62rcOJmC5qAR
EhZuuOz7pH1FsRLrsblcigSEjvicHfmoZvsGWq1kzoDNFacg9hhnvG0QGUXBephcJzYdgewetsiq
HlRcaqSWvOJv5LO3osiGUwVZt5wmCY60ROxZzxU/sop7nJ/pGl4nCoWaV1CileX4y6lXTiPSCZy5
uUx6h60b9lyvG++d7CcW+GzPgObKaiIMqrgUHSznOntOhq9poeulccqseu+qz7TQPLoiuZD0nV20
mL6mNntsg57NW+oceEZfp1vAmByu6CovyA35aa9rDIo57lbDHEmzeQ0fTQ8DI9D6XMJEGILsbmY8
wFVzSd9y8rr8J+DcbicRspAHSlCfZyPVnC8z272sgyw7RVnwtM6InwbZXutkwXuDBosWckUTkhdf
VUIanFd/W/16D6vpjqL8rcyra7sjTTCwnNdUVAhMg8QgJXMp3Vdrs8qV9nRDSDhSXo+Kz5XTS1Ev
xLbis8TbdKTjuMabc3B7Rp0iaFtsihM5cmwmNreDwOCK7/Ns64UZWz2OP3rp0xUY0z96aZc8cUax
oi6nHByma1+VnWI9r22uQaerDwCamfXDQD40VmCquLK0/z1UMn2JIH0ey5UAQbWxkBuD/egywXa1
eq0Ty6V5AYC9Ipy10cqx81V4Qs0kgu7g1MV4gE2MkLPMmtPod+KwtfB5mCX7JAk+cSH3T23DlHRn
Mh+iWOVNTJ3swMTj6sWYB/h1C+JD/Gy91GqcuCS9IId15fjzPkiZylRTN2LsFz+Zliruxuwi5Nl6
twYgG4JO2CcKu8+hCqK70OkgkbDSgbNKeNGAx9DSA/q0sDjCJInTzBWPeSq9g7P4N6Dr75FCxAur
H+0GKK471T3lhOciMq+589wJax5iaKezfssuDw+Nn7CtH9CqzV7X3mYdSAsrjE4IpU9iXgnwlWuG
rtb7VHRMt2PqPgdJ9gCf7EwE6ieTTC+2W1KEIZYG/MYp07+tB3KC9LdB2E7CQ5BeLpnEfJm+Bot7
WUXd09Dh0SeTpvTa7ZgU9S/CvTCls/vOJRBozicE7Ka8qlX3Tiu+HKG0MAlgLnty4JB+FCvneNTI
/tj1DkCIvrdytHQ+PDqE1Az7wuEBPMzm+tMNFKDsohJWicM3u8H9gNcVUbTVIrEt4Adh9MRi0tIN
7kHsvYNjf1n97k4swbSfJWu+GqrGpHwPzNUM/9kL4gC2LJuAaNh1E7wUT9JirNEDFcKB1YohSch5
qkHnsp/ZKF7NW9oMnz3e9NTGxEl/Wq+knqYe6M+S+9XV9wbqcRxUAVaGysTVyhOdyTv5lwWAx9Bj
10khel102Dwccov2MsR0L1x1tVpTnK0N+KFkhtjHzrdbo/U4gAVYQqeO+cyvChIULlXLhLxIrFs8
hFeW67zVDUrRwYrEMR/S+9Ux4xkw0A+V65d2CpZLPWCo70IYgJnxll3n6cegbI5RlbX7asjAPjTA
kuAIHlVXBuD0mGZkkGJ3a4LgwIz9tbDNO0pzLjO+TbtL+PUIdKnUfnLrlTilgrwXbR0702xk0zR5
Ak5F6Kpa31HTmD1F931R2cepBKcWle78WxjrbRkMr9iAi7HZs+yWxIHdq/LsxLuhQC6Fxfvsiq9M
OfrJHRssDc3AgVzKlZ088pCFGLCu4f0VXX3tFXRVTm1F+6VcwVOkzqPEDaB35UBYj8X+eq8Q74Nm
xvbJEfcyqQxGxlaBDBTebfg61MqwJ6NfLaOSNXrPU7FnhMHSaSF5JMovqzaTqL36K99a/Uug3HhC
RP1M2/sA5qg+AEaRp2FhYRc0xEjsERfhI1amIXBWDBkAUzN2Av2eZbv8ReMCTCCSZUyv+ezX6Jh3
mMrPCfLN5oddsQHcTT0cx+vRDVIGq6HjeNdVtg26BHFRuEf1gDGorJW8kwRxlGfwo/yQZp1xzVig
a/Zdb0T+PEtmk/Fc4kK5YtEfBbHtQQ/MR3IJuV0c1uMlTqgMh75ZfgUyWNpYt3bnx7ZPwxR7UIS4
DhbfxGtIOt3dWALQh5wtkYd0HNq95pve5F6wDHHgUdJhtim5FWHKDURQJ0XxhXG/aF7hWaEGranb
BdlkuTFfdTXwqLcRg11Arl3Vm2LSWrELfGUuyvueGr39G+QW6S3OUi6Mnj2qJThVlnMxw6HC6FuJ
364Bow7gjnq8Hdj8wkCv65s5C0d1xU4IhZGdLtGPFFf9cJz/soeRuX/0ti6Wz0mOY/g5ozt5zaZE
5LHLPcDLAq52saaUpo/jZLfuQWJGPTv2SJCWXVTtacZlsZyFiSr3EFKkw0eaUqePEQNjA0GIhVoj
pEsi61Bh4Hny7FGfZBIYdRwNyMELnpkz7/sqIAqWyl+Ce4irUXQN+TYk8YoMwnY/IClt90mFkXg3
ReFkvRdD3gn49awVuVE1iVK1zpi/WcPaOtTMrIMPOeL62EUyBoSWPTA1mXJWqNAVav5kmOxnN0ii
PMbbYa+nkahf3e/GweTnzodWfgmtYEA2hAOw3qLSsvmUMZZBYFT48Bt22WQ6yDth2YzJFVt1QiDm
aurVnYd3qn4CO+ZTUrEqnh/IQDbLFblVkBoIupHuVeomuTxP8N1txiLsOpKuQHZdKgeTtbWIGVa3
PY2fDLCaiUIr7MQ5GwNqeSHKgpG1KKV4tP3Fe9epAl7g9AaxAtEC0Sbrs6oGHR1hvmHqK3ahGaQV
Sb6kPJhNNnolzJAppDDVktDYgW0xu9AdsfbvJB2GvLMRs4+PxCP57sWQ5nwybIq5GU0XAuEJaOIu
VwTAas9bKen6SXAcDxj1yVbxyqqw7vKGiv2mlIHP91LBct2KZgUmAug4uF2JtKsvONBRzEZ2O04X
kHBRjopxYK5qZQgBdnm7AQhQEGZPpCMzgSGduXtpQGx7bMuqtT33oguvC6Q9v62lMxuQIIXSVUTT
DWL9cyHZPW5xJAhORmvUD3VXD9m+nZuN9O8tGkx861IklGjZmPJZaPnTYcWFwdj6auzqEXMciUJH
wPFECpP2Bj5qznkcVgydd+BSWMsijWgog7y0yEn78e36A7GI/ZEXPFIAO/1RYlJRgb0m78Z97bxR
qCP9WdSdJYmWMz6bEfR02vHu3NccZdsEstuyNtcGzATS8v0ErEOfCrS8zmU4+PLN8jAx7PI1wN6R
TTManXQITXGJoJS2vZB1haiv0KN30YU5pgbjW/Oj52fPgEnR5c4Saxl+fzjt3VXj19N3ys8tbxuG
JRtZoqJbUW47JjTDbKowZrrPA1MOeGtD6cH/6xZrxReRK+YVnpt9BnMPN7ApSK8yjR3+qmHQ3mMu
H+4912Kgk8mChRzjK8ZLc7q8BMXMrRz9yUWcC17Onh1XdekVU+gfoInrz1ZKZO5qNpU8j6j8LvDV
49FZfT/ABOfV+oqCoWQZMwgOTzGDJzYZLEQKNdL5DpTM1rBHms/q1c0l7y/aEY5OG0kVFoc/Qns/
R6ENbhSJAlGfrD3UpqNfEqDszKP6W2zNHJFsVV60HjC8OHLw46Hty/4iX2w+lojgLGS2obaeyRdE
mFw4jnOROHV2o5n33rcC95NLcxDsgf6O/VEHtf0sl8iMvFiR41CxqsshmRay3lr7nkEGs/IOSBln
FczHQ1jlXXpJjDS3JgArAGJjz4TttBFxiQqo0/EOTVb7js6WI4R5ElEp0epSWTpizfRhnVLOR7qn
BBpCvThfGE+c7OCo3N3rvLQBZiRAjxlMoOQmzZ0gvy1749gJv71R+RrqXRQt7WVNlM+7P4Yo522P
KIGDmpkrt23LA7clMmE3t/70U/ktCRS+W4ctPYjnkbMw2MM5W3zxgcSJmr+zyJW03Sy9Q1rDl7mc
EhuhQBBV2kSwxiFajeK7RnJMlg6u8n0y2Zh0wyIPXeAmjDNjjpdZwc/BObZbsFYSy2aiETQJhAiy
ZsLaQj3C3UB22GD9goo4/oDJjYo3nOZ7XM5heKC+r17ZFoJbnOwBoaewUIqy4k3d29L4nOE25J/k
0A1t+C2GTt+ORC6iGRg75FADD07HXnSDj6MOf5Ax0j2jfjLnPMC2rIg/SPeYIriWaiCTm3xj8J+G
xkfrifYPB5+7hL8I5XLfEdfxdxtJBXEf0mVBDeNgZ+mSWNljpLoWHcIQVM9JNty4uhp0TAdOnT7o
+bnRS/YeDT0zLhHUWxwfeY7Nr0HI5mHeoPywGfKbajT1R+7bPcM6D8e2VRJqCQe0Y+ZTmfqRxQlC
O2F1zgFRk2h3ZeeOl4NR/nfedRRSi6Aq0fUkj8zeqldUqYQqld4GUZlWVDmQcAHbTKBTnkzVD9YF
gTDjLbOXMZZTR0apcLLpkS73WVceyGuKdzTM2luKZ3IMmi8zVr9MwKDXZ/62xuv4SMGf3kueRg8h
K8PyuggUuvCZ0CO4OxFmXOWrfc9SFHFJUsQOcI37PmvNDSzm6ACKi+QLFEr6ds0rIEaQ07LPHIAl
khF3aF9Al9FWrsh69mz5SAOCHcJzxV7VAwqJ8De/dvrgOgnaIp221o3XDeJFmSD/bBGbEOrjkkN3
HNkIs+ELPO3C3mnNZR4yMacasPJjljLRRUkouLSLyuWRJp3Nl1uBgK8RsKzqtqChUPGKBHo+VQw1
uKH++CXW0IzmRDIAnB+7tu+lv3JdUu1x3dvz0vhoQ+ti74SkQjDyjiAqWrrxvtnNW3d2WhXM8wU2
5r9fR5Yge1u8IIC38FtfI+yKfppc259ixY12YCjXPWaZiSDvaUcxOkFudAlgljMj/5NBUTUOl3GC
QPTkJA5KmyFAyz8UPQ+flic0ciOPg0hs91OVNi1STInDVwoW+9OA+3eH1BHJVU8bA2WPgjsbwD7x
XEd6AejKBujUFEX5odDTHDy78K5F73Pqjm4VkVnHOOyq6Ylo2WnEWp/zMjrDURuvavY1doEvGovk
3GI+PgT5vBxFGpQH+NtmT9nAFjBYGTTuZkG6JAi3DYjeUTP3TEeb4lRHciQiD19uE2PJrD4goPKm
sE3AyrQkQ3C028WChMao+xuNsvR3Tmr7rxM3MkeZTcoLbt0A/A+NQjY/DTKQbO+cRiElhal7iCYx
yt/6z5ul9Zqtr8xQqlduYBgsHa1IugsqPTNyTfCBNau9xUJTP/sqBMWaV7wjYOlsIv2qMDkjE7cO
Ygrz/Z+gYyVyUOk7JNEYEHhtoAZKMmPTPQGXTfTih2l6wmnuPsmWnelsZu818x2Ky5qqC+otvdy7
a88NnkY3RLTk6+whG+b1FnEVudOrn0JZ180mVsc4mj/4SGRJafRE724YSEoktWTZQ2Ag4V4BxF6P
pme0UbEues2iAEdBrl5Ui0AZTG/52177lKcxAmrmuv6ZyT8Vey6Qq2JUU5Kv9nHp9njqq2MDV4EJ
mSDWMm6WivtnTejtQEixDNy1a2se7XpRV51y81sWnJ+kmCH7FCnptnE6Atx4bSUBYyBhCe4+VHXJ
c6RUWroXIsqIKPn79J9yg8waNya3Vo62/dC55GVCF8+6PXmnXOEjExaCRVOuUrheHh1l8MdqF22P
mnMzWINzrLlSoJI3GcPlP9+A+Td3RIsxF7VB0Q7zvd+nlFwOFFG06cbjITXJlj9x55kbvywjrku8
80SqzKRmWHqPJEt8lNu1gsAed6MnxHLU/lrIs0/YQHnWSzgnx9V2vWvPaNKy/4bNlAnM4j2OTx5Q
k17m8sJRVQ+vvGw8FBlEOpZnqaexvOiymTf07ynAKiYhzQiaQEqDVPbgApRbYvX8c4DhMAgA09EI
5OE+0WB/Hkh8ShiOVLnkh6GORQvzh4LvB165giVaWdyYPZGprSsukG8ipUeqYGn0ZxPztPJqJQQ8
OY4o6wQmSJ900j3GX2b6+79B2QOHj3ipNfTja4YDTn2PNC0q9togRtxjjZXlMYWLE11Ema/VyfY3
KeTEjXpaE1hr6Ce5LxA5V+WrVecQb5n4+uxxEfZwVSPR/IoUz9PdjIwDOMiogUYaTSG1W/pkFfsm
o6/a5z6s+cMiuqq56ZbZhkgJG0vu1J+oectq1RvXkM84s529NJ6r2TCTShQCFMdniAQiOUqf9ECc
FppknV51eUMShu0PAos1oCV92Uu5VCyKkETv1pVZCUG0OTb0HZpAqV88OpAwpizCt2h6H5EUvAGu
nCIYq9e/n6Fi/D4cK2LVNv5hSRBfz99u9/Sr0Se7SZiPzIBYBwtnGO4lxCbDqRKSrywyQfDUAoOb
CjFLvPBYOJF3gO7WdA/0C0lw8udc4EuY6vrT8RltbvC6pd7LdWHQ6k1aPMMUdfunGWEOJFJVcfm5
amb7gh6qfCU3kUs+Z/LSHOqgTC55dk3yDokF6fOWnwHnYKwIkZLqGgs/UepNdDHMtvOTKj98L/sk
LkIL+VSOs2YT8oKffbQ6rj2I169pLmceIdXtOLl4PBzaHkYRAJPr9DEtWGBjMtMIlfS3VNEPnIOc
iKTLOO1Ri/ntj2Pvf8Woem5r/vk/29d8kquqcmLg/gCT/uO//mcYq9NXe/ur/hr++7f6L98ZFtO/
v7rDL/3rv/xH3OhcLw/mSy2PX4Op/r6K9Kvd/ub/9H/+4+vPd3leuq9//dtnaxq9fbcU9ed/xlFt
wUr/H9W0fft//7Lt9f/r3x6/OvNR5Z//aL//obOvf0ABSdv//uV/YVZ2+E8fihNNkxD829msxH9h
Vrb9T6hOgY3WGz1lFLg4Uf8f3v+fRAH4YK6QH9tSOlvCEgJ0nf3r3yzvn3QH0o6IsgpCGXn/K7x/
EGy4qv/wY4YkDkSBCGQo+ZYb2Gqzpv4nh6+0fNsvVHf0/QXEdtouKTmsi+PczFBlmxuUBhg7QnTX
VTxFazZfMWZX75lr8mHPQptNKGj+kHMOQlpxmOC1FXBtMTfumrH1W8QayxLhTW7rp6X2vIgtedHD
oB2WLebOTBFRxLDX41ZOWX1wyiz5brySOcJiG1rzQLQBu5vAnDWlZgukyVmdC4PH1TkFCJbG2EVR
gDM5WNPpMEfp/NrnQVRfmnGwl7cwUP1yRUtjqcNoQd489LmNPM4mXw5Gyuzne9z7GyFlVclPUH3E
kE8ZyIJdAaEP9+SqoAaLHKAsywQi5Zjmevk5shYPMSa1PF2/vaxIhYxVfpAIHPzEoMUROzveQng6
TrrXlT36e8+MeDmmc6Rvy7Dpkh0LWPu71TohVyRQ5GRGlA+X6GuY/Ld4ru9pm8M2djra0D1JmhIV
gmu1S5xOtt7qzDyZyUQMu2dCw5XiVyLKmj06NSXqy3J9mvIcF1fTeDxPJ4/sowlAWHsgHczyY4dR
D6HznVGnvHH0zyEf4UtEfhPcwxtXt43xZX7oB0J2drNREXzZYSoxKYkOvmLuV8UvkBfqsfVTJOWw
wRBwqWoal0PAZuyG5NvVnMTKDmpv7LyRBzsLzUyiT6RsXI1BX58QfVGwMlwpisdZ8aR6XOueVGBm
1uNwuRgr6GjXCmjctct6L04NfAxmnktrE4KjkhTkwMjMf+gG9JW+Qr9FBJqciQP3c1wqXqpX6wRh
RuibsoqMvslRO9fHzPeBydu+QvOATZpZP1Y6671n4VF8hAvcjzjjddBZWBFJ4NL2ezvu7XLMLtLC
YSpWw8sO903vrG1caabLeyhEwtxARoUQNeRAIZHlV0sX93hyFNCACcxtgFPS3o3EoNvhbiUgxsJd
MvneMbU7tHDLYg3FFVMe6y2ve42mgXU/D1NWcflN3oFjesyZypoXr5JFdpg7vUw/6ryoUStWI1wM
XHhTcSY3Azv0FIz1dU7S/Hibzqy27lAN42nryYYMj926EXBHU2JS1pJVzTev22pPEY8++zBwAXnH
YUFrju8QdfkDq4GmIUtqc/Vm/bJFdS+TR1GZpRqkahEylVbEMq6H2octeuupOgjvqkaxs80wm1JE
ryn9K5putqUom71vFgh6Iisvb8pYeBvwhKHv4MQqrxHV9aOf2XHpTXV2MTtaFKcIyFZLiEI9q3PK
GIXcqARkHBLRlJMrSW0tf7dFM7OWFonR95GdeywI57kBbdeLIo1ZokMp6kXVNnvmfkJftuyfM0Yr
2/+liy3zC8d1SQGS1TQUF5NQQ3tLtZcFFzOHRXY5DFPVXZADBaZYch0lVyobx/DUEDQAbWPweheR
AamqxFraJAF6TpbZh3ZwZ4rotsrdJ7cwJTOw3J0Z8cJteGUDwcvh0+eLmmAIrxJQdz2+mrb4wWhZ
fWNH9b4XlDbdoRmW9g33Lz+9Hhz+gDEyBpoZFzjeXpvCdh+6aOs43wT/d/Qlx00G6IVPwqVS7pMQ
GydKT30nPY2fLlq74DYD8fW7c70WpcrCKIPzG9TTjpVi/mXLPrgtF95XWl/TvmV+q761WEVyMbiu
+l5my/supN1g3O5bEN6NPcCEqrMK+6w9QOn08L7/TlrJ5VMhsmXdDOqHLRPpxohoVg+4ZrcuP+gm
kdtk0FvAacl5drHUM8FCjrt2y044JgwvJV4kFwmMp/JLxdoQrBu2vtcJzVJ/w7qsfO40oSWnjRGO
hU4RUrXngWGhEUhc591jdeZYF6lsPTaQKretguRh096YBYMEtgIycNkRc7HRZNTjS22HDowWF+WJ
T1DX4xgwjtols0CvmyZGPGcZQiIf+y+e9hZPyYVLGXce4Vr8VqbCGbSwu6BDtDUyAJ3guzskrmEW
SEinvqFJwkFhU9A1x2wI21szGcnQBeQR2R4VbLjRkTraNdJFA42RSN3UXcKeyDgINtCvu+5J55EB
Wt8nTIqbZXZwzswO5IA+iQCmV7OQzz0/Hv1oDbz2uJpFXifpjF298aMNK5+WYPYFDeZzZ2MSC0k/
hlGYY8Vw7RyBTdSMORjfTqBWmQWHmZrTn5KznM8bpCMhClOPPiKImKzvfEdXz0BkSzSbPXoHSxXq
hyYC6DxFKL+Jtk7K237pmzdyNaY3ZqbyHWAiS7vElfW98Xt6NL/Ftbmbe0MTNiYpNlaZq/qF/B7y
Xxy7dHjGMHEeDiVTxEtVFIgZTu5iCaLE3bEgM0YGPfkkIyMI4lHW2iPo1y8kfjjpBL9l0rTiOE/+
+ACUYHgmBBLfHQUQvjrAiajpinAK7ygCtIKdmYHmSUklYZseItbaYTyAHIZKMLg1M5Ju4EW5etQy
aT9KEzowyn0MwYhdHFTTEfZD3iHmFpsLESkZy8ncxtTTIM9tto/Spce/xxBglbh2WrIgxjafHwOU
Jh/MCvKXCkFkjriFtMQ9w3iCKVmASOfksFG6RcDJO4s5djh0skRJkfQezq1cAKVjhvQs0xZ6fTY7
r21UmZKGvGp/e4FkPoIiLYt2XTsTOiz5xv3RJ7Pe2hEQ4L71nMP9IWzS7UP20fK2SiD+JKZkqNmM
bmkqhT0On3kQsGyScxuBC2465PHIMNmlwV7tl1j7aGV2gdDzk4XbUCK72YQ6SLvQOUs2Ltjbu/TL
A3C8XFXLmP1osBCy2wyEZKFNJUUhuCy4vDcVPwlmIsw+h7FmCJcpy8XUPANKBCKCgCKy+rI8rs4c
bowCF7CCINu4YBW+4hHBIFOzD0dmu5unDnGDDYg/tplLucjlo+KeXbmcjlgWJp5B2+N0Jxqvm1nG
NNMPWkr/2hTSmXaKUca8V+tShCc1wRDZW0FbAPOuxxlpV5L2wdFTgKQPjtdVZ4uJYXm03XZ6dMmr
q+KlLJN7VCbZgBRmTeGxtj44CJtKpeCsyFOkLKnzrQTjC0blJKJyYZIEg1HVql8o/Ka7hrIA7Xup
l3NEkwbyeHGQSMhkU/9h00T01o9rg6a5yxMACfWSWogdpuYX0+K+vmR9PvWHEU8NSnVYPz+7ZHZf
ixaNzkFkxRYQxDtKai/ZuXGUNW0FZqRi7TToISI/hintV6HNdFsXBk1hxY7pEfHP8OlUUaNxdc/j
e4A9SO3cCETdfok2FDRFM3Vq7ssZegniyfYQDH59j0A1/wzd2vthY5yBlUnN4EL2F1udDeMZEWTi
ZcOOy9+Vm36ZGXZNnCadLx7znUHkjPPO6X1sV1nwQy4jSvNe+NlvkblBdOiLcX0BONi+sHmdmGQr
D0meyEgzBIeput+QRBChUUTxEIrGtmRkUqWQHYrFIOzKw3L5WRDc8EfjjHsI4q4PnN9rIHUZHmuo
ksToMjQW5e0cOT7oCJHhC1OoKVaixGoK+iRN3c9u9thwpV47vut+cFjsFHb3OWmmKUg/Sj9log9Y
MlY84OzdapkJZTB2V7wPc4fmjzBpTrTQExY2Ep34j+xosg8V1ePPhR3YfagRwzyAaMH02azT5O+y
pOUTRQ1uKNc93TwskSaWGidSZ/N0U5HYe7jCWIK1JBRI4wvktOEIxqOZlcVbi8DuEHoyfXB84eGy
S7FT7O1pKj7zbkasw2AH/WmEs+1QIZG+0ZbhXBnKaQZ4vzjTWYe+rI6+Uw5Phb/knzmBLSHinwpX
ZafMGwOn/kOOs0UEC0/n19Yo2e+F0SUu7Ip1RtTwqNg5/Vi+FWtDQ2QVXDoovrLowW0iebsETogF
wZ8JRooIszxJHY4/AtYJCMwZ2QMQs9IctQOqgbe+X2eS2Dsn+4haeoYdQTIeqQEL9qDd6Ln6Vz3k
+YeVOcXHMET6Hd8baWyVZYew3TcToK1SOkL+uHmE9dD9pL2pxn0TTubOU+6A+6OopDg0EbfGO8yc
FB6hQ/tGblCNhc5y6/KlnCP/RTSt9SGi0dkGgrn3vsowtWiAJZf9gveXsDM3M48KqgQRp5Q754UR
1fcKrPhtHtP1I5jZC8R09MOXybx+OnJhEVTBmh4lE2ZWzUIxIUYByTXsNTKJxnfmpO1PIaRHfAyV
H3JMOzPhMbSRcOLkJMSYJxmP2xgGtP+iJcb6W1z9PlbTrorCK8OQfDgsE6XohP89jUVu2b/pw/Ac
rE7qFg8Z6x5Ubu3obQcYxNKsWakH69znDxp2j7SesrJv54ydNAWDbt9cz1CtI7aO0ngQTvo5lKMN
TGQA+kRRLOWtYZQ2su3IoaAkpW7XJ3eim9pFqe4rTh+N7sORJLEdGKJtjNx85cbN/A6zbdcGNq4H
cNZxgg+GlYNpkYuGPYViXOPPSM7R2gwE1ZdImR/trVzlL82Z+DFLjfr+YA3Gssd9qqv/y96ZLNeN
ZFv2V8reHGGAuwNwDGpye5JiJ/aawEiJQg84+ubr30JkvHoSI0uqsBqVWaWlhUVmhAheXMD9+Dl7
r50vuCR0Fe7lskTiKXGn5CYyesZ/2rhZV/wrfPkf9dv+z5pp/88x4ZXzq5baQ9a8JuX7j000sf6J
v5Dw9h9C+PSqyLax7ZWW9l9dNCH+cIiGpeET2MoFxk9/7a8umrsma1KlkKnp8Q9FAFbtry6aUn9A
+NM07mmugen6Z120NWr5v3tovu3SPAPOHkhbruB6f41q/qGHVsQIvkXfAA/JRHAe+ak6zyKGJz/c
j5t//bz/UfbFTZWUXfs//+PfXkX5fB7h2oHjfgTPJ0YXiQGtbYUJyaxk0XYnLO7z268v8wG9x4eh
hKS16AUCfxWymp8/DAIUI6VH4ojns3PVsY0wjSjAU9D4ybnfl+2DhX7nosLI0v/mEzofOHh/XptQ
a0ja9CVtUHU/X7sIa87meTXsqsh19Bv0ec1KDD+BqgLYD2P0VXw+HVPhgqSFdBc9dk7jvJSCsmAX
FyvrDMhVDn/L8gXhDo1dEfPJWRwP1q9v09+/DWUrYH1chFxUaX/omyoN7Nfr7YHOluw+C0TA0Rkn
2Fz+JtN8Rf/9/GyxG6OZAqbm+lzmw9eRtkKzqy/TrsuzDlWeFJN7LTpaZZea/tEqaO2HJX2Og4gu
3D/9kEACtYDDv/5X8ED8/H2A6U+dWqaaos3ydks8+xey7prfUAH/9q1rFxM50ZqBwzsZBB+uUkus
I5h5HKY/afsyeJqN25XmEczlbxCI60/66WZq14fJgCPYl1I44sOX5s6BoUdLEkBSr0g3FPVMlQgK
3elpsi5yBkHzP7+DAc+yFDZ8THiWH8iOSd+rXnjQitxZ6VPsDejUPcQXv34Y//aQsCDazANcpkfM
EZwP7w3xNBwnU64ibRN+Tkm0P8DMwgwx4T0Tdv0oK2zH/3fX/PBgFkmJK3PhmkLX4UYU5ME4Wf3V
FJ731K38Vx35/vk/vSZLEp81sBlksKZ/IFj6Eca3Nh3Y87UVng/p0t04cpnOM7SOIFlS4NqoydBz
7n993b8/Nx72ZvqT2uEBlR/XRDSqlk7rTuzqqc4/D24TI78KvQ3LLyJ4ZoTZ9a8v+LdXghWQ/zjS
0xSw4iN/lghLBJn4F3fQwQ1gZQN+BV9MyvxCp9bZry/muOtO+OOLQR9Js4EJAUqJEZX7EeaLbMzM
fp0NuxZk83Ds2yUtz5mMdMtTCkoyPkbrIPQQFZAIKbZzj15LOC85tkLsx66D9vaVMbHtrobuDEF2
a3Idnc9IY/EMYPHzt5Wc6RRPeN85JuWpAqneYNPbMyYqcdgI9MBr4NzEdKcHTLaliQeTQGiwPszt
58JcNy1WjIt58J3yfFxiKZ80Ovh610V4yRd5htshcPbIbkP2rTJaBNz6YOreVEI7HkXdPFafxsqr
CWxDz+2AOgytr05TjGCjE8s8U3f6dPU4OiIOdGOf5I2BUHjEAQhx6IBX9JNwOPK0D6vnJkH2tOAs
NzTZZG767DLl0IXpUctIHCPLTW/GOhjxkTJ+G24seBLyUAvfPJs5gwaRUiSbw9TVSn9SvkWCWs5M
gkhXiuhrzreOPHmR3T6GzAl9TEucP3CVoe+NvrI6Es+1h6sn5hin059oBjOKDM9ls/jqgUEwCcnI
7BZuYVemy6bqQoHNVGtBhDdDUciHmEqOQZ7ReZyqfI22FEieyekQoF8J3rP2KvNDhhVShbeB6UhW
s2cn+BJqv1vB8vNAeIM9jo3PkT+ftHM3sl04t6p20/ZYME8Xx6VWnRmBUlVVtLcCyOCnCcsLQZDT
MFif8MdydLasYhD3gGknqAZLJDn2o/IZ90zHPPJimX33IF6w2d+AVSmXswG5aIGQMefvw8ZTeC2h
DBFZlpbOU5ri0d6FY+ZetC3fO0LlBUoAGM0EduqM6QGfTthLjL1D/YgcBuVNzMQ4YGQXquzKNakB
li9keEbHtuNJiOM831Wd8e6aJoQyEkr63Res6xQbhQkIvimbViAPbUr3tSH/vNpygC8yFIfS6Gec
E+o9LONk3hbzMjgH28oLbKCFXVsbFML149BJ616IesoOUlo0tTgEOwYj7YAnEzEnjawiykY4lTw2
33nyK3KlKzMgB23D8BF0LpzXyesRTCKXSkjzMjRCdwlpj+fV4o7xFtuDuS3h0ZV7q0fgvbN4iSSv
VdAzRi2r6KliYMMPwXCGnq0VsAKtfq7fZDQ4wVUCrGVNwsa8sJ1ojayJO0NB7gQieZJvx9D5BoGk
wSnIwYjmWY9YGMB/2H11OW3ZW+3nbEatGnkZ+hVNuitGifSB7y6bT0nMFPzQytIyh1lqQjFdJRbS
YSmsxp0f50btmT75gFisEZ0Em2CaIKsa4n7L/lZfgZIij9RJuuKlj0b72aL5eq0dx1VHImbwp0Up
Iuezxs7JFggC2LoPgondOa+u/YJqiGZxYyxxV7bREnzJxKyjQx0r14q3mXaa4IvEkRffyNYO146B
Q58FFrmdrT0XjPN1fKwHhcW6tMfmyVFF095I/B/tRZI7/d0gIzc+s4HR5gBVuzCeM8ZdbMoHgstE
dCYx9kzbjN5q+snkVHmHZj3W3tRR4refR4ZwigDxrrEGwnBw8hC8mGQNjg2otPcWca/liXezZDyv
WqUBsS1JeCDRkIaJ6ENQSP28YuuscYQimlaJP9xUbubgogeci0+mJPik8aPiuCS+/SXRliq3TC8y
fme3zW61NQpSxkOTfaaIth/jRXXFHqKZuwv8oklR7uXw8ZA+vJBOMb17fT5/L6kCiGZt6vjaTDox
N4Vd1G+pVZoveDrHW5GZoIU2VOsH2j7uo93ggYUrGdl7P2Bd3DqWrz+nxEV/M0Q3PbejrGq4wsJP
9yQMt/454Xz1EZpLPex8mwJy0zBIhEMio5RRVgq9TprcXFmlL3d0IzCU6TYdh0Mzt9W02kWDFXoT
tNzCSSCiJJDWfMqCuLn3s4gVC4VnjuJ8WtQ+smPaapbrFsybRpbV3O+W8NgV+El2unLx6aJS69+R
aa02lKCxHqM6A/Bp9Uh5hUBNsGsbvP9TxsThIOBgdefpLIaTjmL4F32EEWsTArw/MYYMG6beoJhH
8rVhQsRT/9w6NJaR51rEHAKHna56ZZbbvE2A3xBAQkJVhAGCZm+ENn7PCDQBblfmokK2klb4r9z0
FULHnMCwa9N2V8eG3zx3VY7pcRENdAy7l9GhslJ9K5F/Nvej3RH85NALfV2/2q85dQoFVjdiaJbA
WxPEXgly/dnNemw+NjHTXT6pYzGgJthXaRvd2PgGfdJCEHPPLp9/x9iuLffswvY6OmhqaCT4gdaB
WpndLNZSN8ilEACeQF2zKIdQ8djBfbi8OzBA6M/LcARZYTElgu4yxt4+w0D6pRO4nK7mKccvVyv2
kHtcJ4gUimDAOT/2DljbUps9k14Znvy2TN5jAkbSLT5khk6Sfv9XD+Vpe8j61AqOxGj631OdNhYe
1D8bil6p+EZlM+xJNorCI8MUfh5DputQj+50rP0A/nEwz7G7qQovfwLKkLSHEvruQG7KCDsOF1UC
0aujZCaFwmEg57ijITYLYgcYtaBKbqaGDiU575Xz2uLfJkLNhkK6cTNQFchTLP0KPil8ruxOC1zW
dDK3ME3lw4JzHyl+4KgeXUFfvTLtgG/uwoKi/d4IgrS6ZBLMuJp2+kKgfRgdmoDRVYRmBoCoLXH3
ArqpEP2OurW3xhifvBdX5NM+08o+kKPU9bhLQ2yRLRPIfeMw5N0oSp63hEXxM7AUDyGcCtHeDxoZ
8aEp8ShsOqovhGqLZtkk8xuLTKIbf43gXJjADxamEWZLmXrJ9dDKXUaGxrQhviXt9204B2isF2is
OKB7e8G+LtoTZqHmftZxap+F5EbpLf1Qe9rBTzH2FbxzCH2JgREns66LP/vUpRYz7cxkuIMbPFym
T3AcNw7hk0vuDm+ohREJRhUt263lpV6AXpy2MDmqHmgWBZUNDhNZ2JRVTUbGqtQkuncwg/Jd6yop
EVwb54zWOu1fLkxUd0wb/QXkLZLLuCji4TR6fveZWNKyO1fKdtmBRhU/mkFSlOlJIQWyRCyva5y1
6miPXuSdfIztHU7HmgI4cdrkaVzAlDdiTPWeSYT2d2vO5vcQMJmH9jOM4+3AMv19cMvgDjducG6P
UErAkZnmcZB29tiJSDLrjEMa5DEo0ONq9iDVIfDDNYoeScxW9XPzCN6yZ4/3e/M2VXF1VybD8NA2
jM6ox405+VXHh25Ix/NwhOsG3vUYBeluVgEpRoVCIjRlXnkL0ihtt7U0MX3pAqwJ/V0jwCvZa9i2
t5AO3DvAG2A4+o9WnNGVlzMa1n0Oj2IEuTHwG3HaW6fitDcw1LaixuwI7SjmTWMGuvNLb2SyorR/
ATXb4AL0HHlJMK6LyEn6jY8fy3GRFODUJvWaMi7cdJ3dgo1FfRqcYw0chj30Yu+u9CeVHQ2W2UtX
h8tzQ4WH/2IqKBPtNqCgo8esbKAv9Xjmd3H5FM4hkKgCA+oVXyewtyHVHcIQPxa3HoazL9i8SSAq
UVXddYym75DDlg/sQEC45NiF70MyQfpBPNXfgPJYCoRQGZPWuZj1lQ67FgQh8/bHYKkTrGl1jhae
Env6OsRFeaVgbHPm4IsdCH9O2nbPMIW0Kh1NMJKLKGbEh9K6PMMiB9BCuKta3XgWI9/Zn/DYqd6F
xOiSnkJ1nHLzwfGVZ27KKHwbUrDeApE1uOb7oUoPQZCEMDF7NpGcIdlmnhU+3ARb5XeH/5sgu2iq
35QnmCd4sWyuxzTkSDChwtMbJGRjyn2HJADVxRyIeFCocvsFEVoytbLZISMiURDz3vgSRS4JD0x/
3EtrZG3fDe1Y3aWk/rI4I5zhnBFZY4OVCqvpOcbXEfwSS9HDYNL4TQelITqcQNfrcljy+IIlsnhp
Z1lUoMknfZeHbGOYOav+SwcigL+NRnkcW2aUO1VV4aPmQcjOlKiKp8AeRrkqNyD1BL3rk/KZ0Ips
dJc8OLw7Fo+EZDCIkgQEKVMqFvbJUra/8QmiA14+8ExSgCn1vWhxtqPjbaLzDmYuQ2zQJ3Au+Gu0
l0Q38YqMAwsqqk9yP4bADsAFLHmwsj/JSd6stuBxN4JhsveDxWF2MxDeNG0Y+omSutfFzbwg8jyq
nFV3W7V4irYjv3R8JIZvCNGROPKeaTTLswtb7IXKRSHJc1NzXYVo7TfI7zpJ9GDKKFlQC1zUg4Gv
BLkc9U+Ckyy87bFgF9vR68eXQQblfcZxKV/1QuVV36CRu6IxiEyQaoLqozH4NDdmqjAo9xxSU764
FrYoZhH4DBjM6y9onJN2E1kBky7Irv28H1LGolu318W9Exl1b/e25W4QdMu7OIsyTabowCGq1pSN
nM9bmFZq7pPX2M88ggODfHktloADmmZIR9nr8qyTpcD0E8mRSL97kxtDm0n6+ACnMvtSE678bgTa
7MMEBozgPPD47nFqk3Re54JkYFIoI6ZBDu5991J7rq7LWaqZluGCj6lSfe7vQo6tPoDvmcDx9ZO+
x1ZK2F6cxvnRQXYZn5OgaO9bekgSFEMEox51YvoOe5tmY1FSBG8wCi8oaSKVeVu/pbrfiHHOP8lO
Vc99n8tPUWv7MLhsw5EzZrr6KpCYoc2dupchYh638RsWFMRFafe57jTCQQzVcXrAr5Dau8wlwJmh
NOP9g9eZ8I0CoS+3lPszp1ksy/MKJ16jKeEsjRvP8fWV72f+neWW1kPv5/VrGOYLe7tMontwcJxn
UqbM49bCAXA3UUbFa2ZaHV4WZR5A3x4Cfg7lAX2LmWPJN9Gq+NnA0H4IfZHQ0c9hxJ+iDCz6pmsX
x6wnKDwnQntLd8YxlQKzEQ2BbYxbdXg0Y1fcZ3zR0AsREZ+yqIKTP6gAWaCNEP6iIVVyF9tTecFY
wjVQY+xkPLGmLnhvfOwA20gY+Xn0MsScSZczu59Lt/5MOClhirli6L2p3SKllGbMh+mqVxXCjDqi
BLWyrLktwyVAxix4CCjVWYn3lq4SRqfW4EbH3m3NtbIs8YIdAsuvMLysO1Zm5vu672kwGboon0hA
q6xj6PuIJXsVIzvGr0UmYdH4Cn5jECb6tWTShY19Kch7mMZKPYE9rMzGC0ZNmC2SBrwm0k2vp167
BCoEzrJCkToQA4TnBmdQdQNv15TzsEZyT8Nj55NEgiJ4cF6BrMcW56AZ2FxveDbPSydzotMQJBXO
+MHKDv3Eg7e1kjnwgK4Wnbkoxrnh3wBOzjFe2s/jZCLoKkmJYdttfH6HUlrxa71kXKbMWPYuABlX
1qkhvJDIusDjwVIDoonNOBt0DXEZe+5Jhgu3FkZWWWwkCM3kwJmwvUS8GBdnY9BKUruZPJNim3YG
W6WJZ2vb1vW4HICeVMFeRXhLdkUg1/A4uQyHlKi9fOe1PCt7W9FHeLZpV2FwL2O/3E4oH8lxKlzj
bSXnyH7r1057dNIWqqWHWItwLRMKvYP2Bf1yiBf3IFu6Jvgv3fTUcIjy8G+FTcDY1wDtbVxves+c
Sj5z3Jhnlopu+ao6zz1HMQx6BkGb9+yq2X9qUgFZqkDtuR1UDHfLnkb3nf5xTkGioqTZ0YvxUQiP
ov82+jhu1lK9fglKz7nWnYkm9ppIP7BvoYVXGc/pcRiG6pYph+1f6kaZh04WIcIRuw5ucr/Mnuls
hNkOygPcobaGb77Drxwjt/bXnd8Cw4SVp4arhtU0KUsE/pb+uoSGpgwC0HFHsmDibcOpmiFFdjbM
5AEL8ZtM7fAOO34TAwQMbfdy0Sg2DmnozF9QXyDkdbqcfpPVDBLqQYPE8AZxOFE4JDEhPpd+64tT
0tUWTzTL7K4bpSndHeamlAkX7++NWARvRA8N4XsJ5mM4SU9SR0yY6JFFVsQ9AzBdhuLBytLqYa6Z
5kALwDZsGsiyKCR96oYOdFp3GvzOR3U0gnTaTVNqPlUT+oKNGgdoP/XAjIHOH6bYjeciS6PTJvxP
vcqtnH07RkpLJiL/ioUW6lb3/hTAoSOEZ9M5YfYa56HoIXxokjWtBBXGdjKefrKLYIpAma6beo9p
gAtX6UwVjxaBaAitCUVW9D54iOLoKbBo7wDzRmcNh7Ci6dYmviIt1WqcXc5qgCarMQpkFhKcl6SO
V+1xmxIk5aChAZEulkwjZFuGZ12UHpxlbAlU4DbNpw3xzXgL8qnswZqGtXmq6qp6V6Ht3KUY+8O9
R3g5XyYNrG0v2vqBFXO4EgMiEc7ykHrRg2XiOy6m7A1DCPb9JJ+s6IiLA3ybmgfnOXSjCVlO3+h2
i3m/v3RrbcMNhACPRzFbmydW5QLRJEYCptqE7Cg8QzRBqiyWTisCNkDCxoqBjp7RrtY3QW4V4Ajl
GN6CEZTzJnam9CaYUqFo3JXiFMlsCA7KGYor4gKK9oB5Iww24EE15IWR/MwGBbvetvSv2o3d5UIf
Ki9s4z3Ne1JSUr+f9YFzVfgptpnFb124M+05MvrqOaTRSjwESYTfbfzH2DWFFRO+FeTmHtiwy5eW
utaXsHPJD124CdXB0PzDujbmyGpkFZQ3lH766xjIAamVjoon27NIoDCDkz0kQ9WQ+y1KJkbtNEBO
6JDNPAxTVrPrsz5MZEk42VfGzWsbqSNK6lU1mPawXvjhC0FgXcu6a8v6bTBqCfcYh2kys0YG0Q3a
Gzs/q0ZrfJdu331zajVlG/aYpj9HBM45oSUqLzhUce5cK+kP2RYaXEuGdV9l8IbrAES5oGNx2bBC
QLCs+/nkIxnsPil25ifbEda4VRQqZ3LEVsiy0aivqFCJ26rrkJ6t5enyKbUTHRIDMOvr1DPu55ku
z1dAUJJe0uRbb3FbcUoiWDTRRy9wyYx24f1/rwF1WGyRs3U5sVXgf2+lgOeJePQcm4gGuof3gWY7
9lRq8sK8B8FisTL1FsZ/fHPksrc5Lj4PZ+VbNDYpUezI2+js9xXDnKoGXLSRQQL5aUwlC+xMcQhe
v+tgn3Bm0xR/2qm6UyU9/9zy8vpb6toxFgiLuQHr5ZiofaH5fg5qhiOxJUAC/ZFoQie5QDEYwSRZ
/AQxY81jwmkNjHrhtby/fth215jY5y+TpwKOeRKxGNKoPlk2dPDb+mgxqAU+Yc/NfWyEehdkcEOv
MO10ldeAiNArShidAug1EsfMcj7LuKeuCBWmrJ01ExOxlRGPBTLbkECMgVHmvJk5ZKdnTNjc6xEo
VMsxVQ50Oka6inuvwXWDMr4hN4CqwQBwQrlOapgfg/20MdrcIzuLSBeAjEtBSLXoXRivSdwdIHjg
OODG3KuxMvaNsz7VFFdstTCiDNwNP5c0nSMGwlAycuN+Gqe8Y1xUuot1LYk8iPfoS0IYE9nMu5xj
pbb3CAR5X2VjhfoYx4woSfsNQxamciJoloAL2uLkw8TMsXTVpMcwpZ/xyeNlpYAUbIyXGT1Ra1fR
eVuNKEP5UmjPsrYG4GqyCzlo3lKJWNWeQpO6ywdM85DXnAj26exCs+dX8pM9ucxDdWyXxc9vRlEn
457OCDC5MZ5B9GRTFIiNQUwe7POpDgtiSmkMbNmylwoHx+i9O5zVOGqHeEAgkjHk2gBZUsuKdgq+
Axzx9LED+M0EtGr8sxDDQXk2cCy9dKqEcPYQeRHLFvLedluIQebHkukH1rUgHC76zHj9GYm81jVt
k9VlDl4KZ7Mt8cUFdRK/A9cCy5IwDcwPGg8E6YZx662G2AkWo1OhmN90TTPf89oW1t5ROOdOPdFF
+cH4dnid5FJd2ZWs3vBEg8FZ06999OuZ4UgXTohkc6KBw62Tpzj7XF65cJNDqEgOQWggpTpiDj+7
+ZrxHMCxXZfvFFS7H0nOrLje7RNl8AR9tcYmvxu0UNY59a/vHPEa2PE9lAPdfU1s6rCDkXPM412E
2qK1w1Wza6IuvOZIlU9/fk1XLy5GEtOLjSuUzjjk5pXamJnz2AGfGe9lbdQTm2UnmAXUbLQlhrj2
wCA/T0+yyvtrx3P7/spx2qn5HGdUumTs8n1vosgf8Iw4NJBROA7kOItcOyAa0yzBds/2rA4AY329
x7IvD9T5k7P17Lzg6YCy9RnBUvKlrRJwSkB4MVbXROx9orlPmdq7QXFXdEFwidoFs6WKlDFrHRuD
E2QgEB8KB0s38WxlQF7OtDJsJSgKUAec3TrI6QEKULI4FPVIPgzTSZKD7h0muRQvDos8RwuNxoXO
/uC9NGboAZ6mmODw1lS0JOy06Jozrpy/BINlkwDY0oYwmZ1+h4eTPU8Jkjp8OXn/NXB703zj+IIO
6wDUx1UvFYtVgf9Y0DuuoXsWBSRPL2CHWHJlRTsvx6xEKFTVzOe0xap+33g9s8PQLxENE0pNuLJP
IjJThJxB4obQGT18B2aAJ6FuG3quWPqj8J4pRNxxmBqb11GBt4aa5dfRRsCAVMcxZiSDajvQ1rYG
f0K+OXqCU2T1EYaPPkj03m7QLe1TNsq7UqcUvjSc+jMwHWW7cbHPPy5x35ZA0IOqvdDM+uUevBRe
w5r9YbmbE0dORxVrdt8UUwThRTrHnmQ5nonPq4Yx5K6j+olp26L43jUW/9Ihy3tpnQE2CG40VV6B
p711PMwxMcDyEw2ZAVSEiKitXoOg65dHEzkJwaKYTwgO5DTPjap9YTi3h7q4TuoUU4Ttrz4cOtR5
BMi6CWm2DktBE6xpSYXgve2hCcco0IEeoy5eDk4yYtOgl+GN5+PYTwgsCjD2oWEvY0SkkFOjO+e0
MMEojbfQi4AdMR5c+jP+UjJKxgpEdNfGpRvCjZsdScEC3GJdpYdlIQsLs8wmdxDHbtBEMElhgKN5
9YzXfuvYpe6sZQw5DFrwoLe4UEhgz8nUOVPh2Pl7KHQ9rUXsWwTR0uaFD4bf2WWWDVkWmi89/G1R
TYxP4TXp8cJyCb7YjkFnlqPTJ2lw7jDfvlzmDqRt6sOcLOuUfEcvK+rgKNKCWFVV95FgfSQxgQNk
Sue9b0RyRMnp8cNhQCwPJsqS9ITrDGpU79QwibYRz+V0Vme597XygQw4dTfiOECuMII+9UGKX3Jo
6FlDkS3Um8DYfvHg0t6PocVMufmuSwIRsxZ4EvQOuv9nA63SfBUWK2/fKUDA9JZgHdFAsaBaWzTq
iDagYV8+zpxbgc9OS+uf5WjX7duQGtY9y52hU0c2c9s7JHDvCrh5mn4/qBiGuioJbPHJiSQ1/EJj
C+Qqw0R4w2Cwgj1OiNo8g0lJyxtpBbVF3AWqjy09C9p/MvHqf0nC/r94+T+ERP/5v+cB3Pdl0iav
P4mX1z/xFwLA+QPJGsneUnnSkXj+/0u87P/hrk7+ABu+tn2Opv9Luyz5R1j/HRvOjovPQvFn/tIu
SxstdIASlD8q0cMhDvuTxgAH4S8VMQgFWA3//b9/VBWvMr0fJJF0fuXat0EjbdP2QFn3s8QznRTu
PoyIQPiZ83Z1OR8XHqtdHPbD3WghfZmbZbrxETcQuNm0xx/u01+/zo+X/yB04/KezWeBZMBmiw3z
g3IRyAh9uFjRoapi+wbeUc9IMZzugkaa3T+8FDJaEAc+eloPybeNuPwnlbbFuLQFX76RhKLcT13q
bSkCcMySw/mbT/W3m6qQCdqudBzGp9p2P+hMIU5NTcPBcYOEghOLY9GizYKhwJYF1PqwcMl7b9CF
c5ijOHhvR6YUvxP1fRAoC4dPiX4bdgSkCMSLHz5um6xamCZbEb9Md074MJkNuAxN3R2i6rV6qE2D
HsIs560/5y9upCimB5mZRwnlGA9n7S/fvLFuxb4cG+qsX38df//9WG4DjJeoqNHM2+s9/EE0n8ya
WZ9nKNygoV8auubnVlEXv1GM/inp/en5Vohubdex2UQ4Un58wOo+NUHt0PbJrDIJN54mAnMDngBc
n4v268WfouS66K0223ocKpdjn5F9ytjVCp5G+n3xLS2m+Aa7GKbZuh4qIjLChaKqcIP8ocMH06Ng
0BY4CdPFxywATVoEPuOUJuKczaB1oEU0x3Ld3FOjvv76Ln5Qpgpho7xw0U+7guVFiQ+KWMrAYuYl
wwfY44MElU93g9eNXmsx7tsuHn+j+nX+zQVha/jojbkgsuYPF2TY24+6YmDpsNsoUHwbIb3dEPY7
EWZf0NPdVZoAH47rnNdeRtsDXIi9XXfH0isvIxoPsPSG3zzsLIY/LWLchYB74Cl8GIh0P/oGfNey
XQuCK/5QN7kzjl3si3B+54CsL+goiC0Av3z76zv/8flFFu/B0eOl4A3nbf/wfi0DcINIBemGQOHq
LBYUgNS4w2/k///uKrBguFAQKA7hH64CuRLdkkAjMhWQ+Ec0fvvQa73f3L9/dxV2AcUXizqVZv7P
7+I8KS8kBZQndMijMwfb7Q5pQH71j+8YexzTJ/B7glHoh0enptdvTXjbNllSvxZKjl+culHffnMR
8bcPgzScyzjokljr7ZWd8+PCMoGhqpwBCn7Qs9gj3nKzE8CrwLx7Tk78rbGjpxYuhn2KlLLELs8W
391HzhBZu3o0+Yj3TFbiyk1Wc25vZ351JQkeb0+tx7mJyLeuIqiDQhriMoJ0tJzMDDU9Xj93bzEE
1znRgLlmbEfudXWl+no253CoSGqkR+4Qfs5ctT+1Mi0ztKMxxxs/LtU1JDlAhEtu1nx35IAMyJog
ONYl9rXNwBfC+L5wh2zXROn01rlORnIq0r9yAyWaTkBNDRldmyGSp2luphyWrkSx2VWcQz5Rj/bL
517Wi/0QVjEK5YGHaQHq4zRfA7yYqIKaAp2H3XlpcfLpBWSgLIBc7MoZ2dt6MinQWjNUt3bN0M7F
oTauph9M1+HJNiT7oVAPo+5AxJN7XdZNZu9nWA39ebiYYdmBaqscXCwoey6Vwbu+GwXzhZ2bKNRo
KnTie6Z/IBQ7Fxn3gShHhvWOmkN69eQn10dESOU6b20QOtHusti+HaCHgE5zohXbAb207bSQgyKi
ueSZdhT3BzY84biZD6nNRlb1pcKam+3REtAVN+T/1AdEhICHIpgU0dbNi7zbz54b3XYo1QEUsmdf
QT4hezLilq5YoE63fBkz2avg8oeXaTbZe0NzDS56lGYE7PLbPzRDw0OQKwWHdHasa34YM5Ms5Di4
bxiSTUdhgErvkyxcnmgizfYlg4K42wMutINDMDOUnlVRhmeCVqgNEXjuRiLFZJbfWAMwioOTkfG3
w9Wc1RQYvfWMUBU6kGVqzucmb4oXLYfiLUxiYqmoSZPkcq6nqIIl1gHJZ+UGMjb4zUyPgjbPu2Vw
5e67iRiRJGqYZzSJTsWu5bj/TZCTAIau4ZCdOFk+76LaWziTtUSRVwtpeXwTLqRoHq7Z2YfKchAk
aZ8W91DnOW4eWTQddSS+A5owk3xj9qitfYwshCFnYcX9IfYnJ78Aow6ggkY+JEELdVmNiHzcoglH
hWE8BUsDvX+XbaPKqiTHzpZdO6n86BXzAiE7Xp2rZl/MlnjTU4Y5GC12NW2aAmXGLrKL7qqop9I/
MxK623ka1vNw4xKTyKsDWkUw8SQjDbVNo0FXk2Ygdz6oRoB+c+wl+wiVF6EyboboQiwGDivmKTUd
y7lf/Bs0YuLFA5ZvbsKWfIQH0B9uco4BOTlf7HpwGbkOaHlWNUi8BQsHliJBxGiQW1vk6o5AF7cZ
IF7A9tMaTtcGbfkFE/14K+M8Rr8HVF53ez3WLpO+DCnyQbWdBx54IAlkW1cYwY8oqVTDAGbp8qOI
8TPtiFhuySq3B1+eIBfSDacuje8s2DLwPf1SjcwyfCAG+C6dYIvzvFUbskol7pYlICgF7Ke+qE07
CLpgRcDoA0/EFTGvcbWDpB3jnB8Ltdzg1KALp0Wtvq1KS+eopjmJD2SdRU+TrpmIlJC/viWy8y9F
hc5xL43N9txPQbqHItNaAFO1ufCc2oM67IeXYQobZVNiy2Csk5FiupvyGkJ13gy8zSmpo8g0Su8u
kY06s3QTjDuacOoyM//J3pk1t43cX/u75B5TaKDRAC5fEiS1W7JkWdINSrYs7Ftjx6d/H9CT/C3N
xKq5T6UqqZnxBCSIpfv8znmOi4m+CWnxpKgVO2CQwI9dtmaC7cvCL6QvFesJzKm4ldZ81Fpe4y58
46Gwoxc/6sWVIRe3OYX3PDP28PLWDBDc+oVGS8A5AZCHsbkewo6SCEfRArYtnZGRuVIzQ12U/+ZZ
O958bhYCq7+sMpc8yxDn92IqMPfUPMSwW5cCpE0Z2w3lZx64cyctkNJtckWdu4hPy5QkKHOGg2Ut
XnjdIarjVIp7KYBatoV9oXzDOC+b0cKa4fj1TV40ACTrUqNORAU1n1Sbrq5zKxVRAj42JSCoJ8t4
5Y5oHyjpUc9VXRmQCDCWUy5VxOgoA55NaOJxjTnMxfM5bEa45tk2phGCSImKAAiYNJS38Bxc5wlq
J42hlFV79LK4A+W1AAq6cmtEhXE9w1zD7T4aUP+hN7XfZTm24b6RFSYhY4EJxpyGkOZuTOvR2uEt
jB5S3lnlmYyoJNo6RtXgTqqU8SkKC98PCoalt6FaKTWpSGIunLxP7jIMGV/8qQ5fC2iaRBca1uwX
bLImj23tnJSHJa6j19YbYsn80S7uZxZ2/saKWkBW8cSFyTh6LSdpDCjalEZrfQnkor2gSpy3LnOj
+hphmDYqaqmsLzml0h6BIBjZS9eAyKKP4EuVtZIeJyu2GNKaVt3AP6LuEgOwmuedXC0JN26d5tOJ
6Fe7Ibw8Db6GE3Jll241rqWx/gD9SfcZT5lm/F4MkhGWgKiT8VI1sAvzsAf6A7hmsbEODZtQYbyl
Mk8s0ENhV6MKhqVZnqT45DBW9Fy+Ng4fF1tmxyDtbsHpwa86lE1xJRdRJoHys4lRLyErCcRFz4bY
T+ha0TXJ/hJ+i5ApNQjkQzs89/w9tPCZmg0PY7c7rwU2PBvBsVMvzCNqXxGb4Sk7t/ZrH8N5DqYm
8spiR/xC0Z5yXOn9T236l7DYDP93ten8Rzk//6o1Hf/8n0F58QcRefbUkMVtKdw16fcTN2nb/BOf
1b1C+li3wiy//x2U/4NNE4oIKEhIwtJT/KM/xSZD/uFKk5vB5fGvQKfIf8SbFNbbnRpbDHaOjufY
FmFfzzsGEX/Z9Ycx3iKaer45UxkK6wEbAwxG3Hw4zb6CkNTNZ39l8Z4yKQaGLnnXljdV6FgekRAa
GF8gLfG8OBugN0yPv5zEj6Wo40fzyFlDBWAHYa7wgV/3DetancFd/zJhJOblhFyEPaDISzTsqa/d
DySit7sU0keuUpZCfLMF8xF842+PNiwoRLKnN5UXdBTIdsnv6ymrb37/nf7uKDb5Y8f02K6TIH97
FKqQMju2SjJdeNkwXaTtaV66wwcbu/Wz/p/G8vO7oDORHyVdTRhx/dF/+VE9s/Ij12oYfIqC4UU9
mlf+FPcnJQvp8yw2/J0Z1z9kG80ffL236uGfB0b+gOWw5mW9d1s9bAs4hI9OvTHKD7OYx1PdYmMT
GA8+2O6/1T3+PJR0PJQ0idhivjuT9Ihj9lgA18FyL7d9x0IqXppn5m2vJpHTD8Sxv3wxdifc1ati
TCBe2O+uDsyUWErwwm0yShs72Zg7ClZ/zIrN4+8vkPVjv/npwC1wCLAS3PvE8t4plamJuVFiLIL0
JozAIji1Y0kodw0ALDhBY3nOzGn+IN38l6uSqD8UD8cjZyF5EvC4+fV6CUkvpFOODzQbtVvsFvrl
XslUINL9/sv97XFWSJGLidmFA/L2OMOqoJMVTLBZxtXDSkjGcV+n335/lHeSGJfGSi5Q+ND4j8lf
vjuMkxLm6iwIMuDHqDuvGflQYC0PSQSWUMvLPAK/lMoDvGwURH3C5XKSqeF0MatLGlOQ0jQKg1o+
kOr+7tsLT1rQSZCoUIHfffuEeSBkT1ZKi1Mi6uBqzmg8/eAC+psrFRHXcXmcC7GSQ94exVxoChkk
55iZ5OhtTFFNkiUgNYXwuebsI0TIX25DzrUlLYXCs75I7HeHk36YEcUPY5BQkbEfpfckBu8cO8oZ
jK3og2f03x+MAYXv2pbHN3z73RwwQq5sOBgdeCXpS7O7EUklFVqybe1Cq2k+upT+ejuuAxnh2rwi
eSVb744YOlOqR8HtiEWxuUpjj/Cfd0Y2a6QhVMG1PxjdQ0KBxAT4CL/mAjEZ5/jQNDSqGS02ez7t
XKb3MRD3f3w3WXCqUSKpqnclmdy3Z2Ol6bh8ZrzDUW/BCB3NrUUa7AMp8q/XE0dBx0WJ5K3FBOPt
UQSChceR6MtpTTWfL+6Q0Gyo7Zlms5Dp7wdfSqxv9bcPQI6nQGb4TNv4nd89ALEamk3pMFuvTd0W
Z8OgVI7iEGevUleYnxw7Yk9CBVaKq7WNvF1je8ZXzPXSCzTZvn+k967PEqLHqNgstUw8RysT/NdH
IxJX5GEHhy6ZwRI4GQcCE6h5OMw++OJ/fTq8PdC79xnYP+qDYw7E9HwNntrxTgj90dNhvV7fn11e
zuAlkOgZor67ZqxutKQaOLtlOYDD1aVNpJHOb3U/TmmfnHRWMs6nTJsQ2MIGivAH3/LvriZmYEhk
wlkfTu9+3Urk7px0PANRAJdg5nm4LyK3C3y8dye/fw3YK2nq7Zdd3wL8ZgKdnmnv8T3xyzLIbAnv
pzYBenCWbXPC6B4QhdR+W/BwJAQS9Inn31lyKhR7thYDojWxmeLt5Aj/RYTC+5IUYWmwaR3pJ6Eu
t64WIhqVMXjVN1b2TUm1awSAFLdCH5IEj2MbEQ/Vt6ZGemnCx66ee3Hm0kkL1KFMLDzzqKzZjYFI
StZS57P5OZ4SXjwlgz1N9o8oc3kwdU3mfhN5I/X2YnaWDp3VXKiPY8Sx7VM+E1XOg+72vtU3HXEz
1Q0BPDb7UFCdhc2uT5OXyIj8DlKxEalz3LBLRIEorYV8BByoh9avbdwYRVkpRkazPaDH0GW5ur67
ghJbT5PoSHPniQWRXVxkOFisQ4Err8epXjjuvJH2MObIUrkbU7c0FGwmok0cJdYYXuq2dqP8JmYK
pP1zs4qkTh9Tmg8jZmF5jGt4Q3RuQCQkPEhYjhZ47c0QwI1I96ek0rpn2djddQ0f9YY6QhenVVtA
oko126Ztk8h6poJJLLdUhzbRAUSlSbVGXWZPAy6oF02xHRlGQvl10M4ubWHDGPrXjBbCx6RIBW//
nhKbDaSwPEGEwix+Sruql+3o/EpUgCqK3VSOkAzOVGgnj7StmMA4ShZROKRhfUI3Zx2oH9DiGa6l
UW48tpioFuBFnDZsRoPvGJzgmGRMSI2EITGfQkuN/KR0z5pCQyXMS5ZZQV9PgGRSL8wPy5wTLkmp
3Koh7NrRM8W3LRhHGZLfqjCbxjs/oqrtPB7q+V46hUflOinrIegnGKpRk2gK+uyqIB0uqhGGExNn
ujshX4gJ/UGBPE7jfvoc6zJZ486rM9hr/BtGpJOzX2iVzjper9HUBnq0alJw7lgnE+a4ynB8CBOG
hgqS+h6No2GTlzlXnAtmAY2OaG7ZdfWNUeUDyUlb6Yu2lX4SsB4S7l0JGMj8PBYpXvjC7mP/UEvC
MlTDdtFQ3tNSDMMcE5N5m3mT0jvPKg1x8KdcuRFJ3coovfNyUIBKT1NeVckpO5pSnRSGTnMMoX1e
HKbUM69dw0y/jYKGzMtqSnzM+kQFc5YIuXcVixb5zWWTAD6yKkEy8ugHX0gMDPSwA1QRmP7cxj8c
dMNi7XWbsJYCaCbwgOEcgBPSHbl7Ry7kzeBGhhueDwrG+EBsYutbnYl03izugtBZTslGRZRwM7yW
1kimK+XU9Q1tw9xwk5yCeiyozlFeZ9Fz2nrLRWpMsEwbH9pNMDCn15iw/fYTezkSNrXbLBHECA23
vnEFF0QLW/cCnvRCcKXEtxiEMBayACPa0dHPLHwbwni0tlBIPBL4Sbc8C39xvuazkONuYhRxmkTE
b4KhrNMsEKZRP8bjOPqP2dIs7VcZplTFwVTOvjc4LrkLFq2sg0KL8qHAVo59RoCcnhThwp7Ya9Wy
gdZ5YT+hxeIEa+qFd43t00EbhMpMv8eeD86omGPzxGLXUe7qlOEZXydTDsMli1BHq9Om2bMKcNU2
RlJRNLfTKLhlUwLoBGZBAYBZJc1VKyr5QJFASm2Dom11bHvKmaKmcW0SjKJ4yHwapTZjYZFpKIgz
RAc7toke9OPA8D8LcdBuja4qugOocgeQbJkrSJZ25mzVUqcIcCN22e2AJyQ/L6kWmG872mYssfWK
rpEHy1rjKvxfxJQoUHpgrm3DOZ7ecZyST8biimhL+22yZFR5+ZGXnbDoZxG7a5Ke2mc8vK4N0eaH
ix1RPxZx7VAIKwYtYtr4Zs0d1rOW72m3jKzTtWj2aYxS0W5B8ZZpQNQry87iypElT5ycyg6aeJDU
t1r5lPeQ2iioMwjYiIyRPPgk8LLm59rwf4rfv1gX/Xe97//l0Q/91l3Gn/+Pt2zdnQAJQ7ZzXBSY
f+t9BsUzKw0OcxngPgejFf/o3/0y7h+IJWh5oJgl0tC6yv5T8KOvhsEqYo5YdyCmUvKfuMsc7+0e
ysVSxiwF4phDplh6ZPLeLmjpEgp1kQEiGo2G/bA2WymxUU4OdKPNNFtcuoFXh2C4GOqGLEYPkb9k
ABzXr2sgdvuj0dlXlj+bj8U8RjZb7ELVfctsrrWj4qGKOny9O18yRG0YC/H39DPvHGHerEAZNBSG
BsloPTmT35ALiDUYbsgYhjWB8Vli3GdfmHaPbpBTVz3d2m3JlGUssOsGE80pgNeZg02b2iubc9z3
xBp4Jg/xfmaFdDtnbQZ2z4+jK5V1dbJl6owNvELYYc5fDfFLZHt5c8B7b8anMo2N+gJ0iql4m1u8
HJeWTFEgJtoQT1zvaMHwsXxezqVh5MZWkg9t0kfZTTV2zyjWC3QImM3pvaysxmx3+eCO4tagxcs7
tJkEC9/0xXiXU4jYnkiDcNA1MQbfZNhaAhXnV1cmFWq9Yj9LRnibJUOX7a1y4rNQPA4+wCp5iG6a
rsgZ6Fc2WWIZz/XJVPsl0WqqaleumG7EgfC/FwU1ebvhIG1ylFsyloYq9h7v037Ydzprtdi0TZ+T
QizQ1KLljHLwAW8woU5pnuVOMp0S0wDRBOlBf2P1FDPtL9wWwlACVhXMOwLwOllofs4ZmE8I3Z5F
1nEsgXeeGcV8nFeAiGN2EUYGj1H351DDOU44vOO0wzxOProaiMaeCnnGItnPGUl7HJhQDrsiRo+D
lIJKANIphufVJ4Vg7bkFlMoIBty0u+z8KsXDRMaCWc0yt814Fi2qvWrw6RgH8zjZGXBcTycjWVDv
RhT+Mu/ynM1AsFYaNBgVPCZEI0tawQscKgRDQzDmDqUfdeYzV4qVZ33B8DtZ23QdPC2sJMiIR1V3
YayDKbxkzKjc47zKb8mSb3qHZEiwHGdaIs/K++446UJ0jV7dWKUl0qjLLIzSHGlCQrMyqlHTaaoA
v7e5YkUwzzmOz3XChu5ufKLpmrnbmI5rjEWnfnkG1T5+IEO5TumOEzsXdGG/ZQDMJM85TvXMdcCX
LU4ktstx7gc1y7gWvGWA51lRj2ccbwO9w2T2rG1H+fwTazjmiM1xpuir1ckSYRqndPw4d1xfXkyr
ogRTCK2ezCarNIJWwLaVmeWyji/bdZA5YCF4zY7TTfs46aTvimVXfJyARh0hAszyLPT3lI2nn/2q
6Ckn9MhTEQid4sdcs7rZUGPRjVvzOHMFOOM/G5MLRC07zmcN0mFMxdexrWOWYbVziVXcO8e5blaC
FNpyty7nNOE2zyxv8fhDjGfaUnPgXIGyM+NFDmcEQFBys1KKCCvPIhXlC7CC+sPS+0zgTSB73jN9
9oV/xuu3wLhRmViZ8o3kXhuhaOetuluZHOansMZ9cePNjkMpAJg+KpV9n51ItdMeptbncRhpJsCZ
CJ09g0ZOsORlor0H/YIPsVCCwwIyCnxlsD6jszjJJhk4AAjtkwjvfPaV+b5XngBLa+SG3uB8/kx6
RVCfFA5hcu4u5Aaf6IT3CGniZOma2yy2XZIQ7EXWR64c6HA+5f7k6c3zwltmbzf5kDWA0oh5Hs8K
DpJDcdEYVWOoBzy/d2EpDfes9lVY34fpQNTD60QMf06UXREMVucQGUnYFc8PxejYxHIpcRg2ovMz
UDBkx2R9Olmic7+6CYosaVGeV+Gu94wkxbozuF70Uqxe+nXiPQNwmQu2WWRLrMnes0Opy13iAT2E
fJ5qqhzwNaC5jU1Vn3Zl6T13aWI9DqNlGLfD4CygfEQvb2QIFOMaY714jhcj84JySuf6APkkdoiz
CCt+EOyJ2j3L/d7ajtZIRUBsmH3MLN8Z8yuP7NR46JXdyzufcLW3owpMsRqUY3SrrF7c0T2CDoBY
ApyHemlYpzUFBiTPvGbSm8yyI7JWHaHWPCSqSBkHs7JAirpgqYtphQwhlCs4MnG1mrdkk93U0oqL
g62X8ctAZa3e+5NsklN+aJI4yzhwg/Vek4Q7otDszWjgGlyquzXrbsAhYWOfhjBpSLbF2mTj24W1
eCTJNZWB42Az4mQbdD5GDffQlu1Qow+YYmhoAVwTEiPr4SlsGA4AlQCDFVb7PjTI1sV00XNu4ir/
HOdJ6gSOTPTelDgQDiOIfYw6pY6ik5JNbnPqUrN75zBIkYFoDJsQXSt7yYq29uyDbefLK9vVRpF+
1uKJqxneCNR9KwpKEDnRp34QxDsStwjTM9TW+hKNZP5i5BPVHaSP3OxqHpis7bDd+GCMTDiFVIPF
a6GTaSa5f4brztuz/q9AoiYpbUy4q+N622VUXLg7k+ihPe7KzHIomElpXvhUqg6KkCokAm9uDgP1
CGnX8S6Q4rX3UhrYEiMf7QADe8vymn06tDAdudfYV+g3qQvfyfac3eGO6HNkB7JMytsh1eopJssf
QrBQ8bTtQMRlDKdKfjCyViLcReQSrHWpQ+NVxoLwMxYRtt25RchzZ3t6+rZQjuPtLSO0bwQ1HfYZ
ygbtc3S92Go3WK3bnrPImvQnv1h4q9MFMwh51vjNlDznfoMPa9d5IvTCTZqqYvwypbjFDuARwu8L
G3koHUkb3XVUHonzyMX6ctUNddN/ryZ3fMX7xy87xJgmSXKBoAzyXjlEJ2WDNdJkVeNvU6dxThLd
OfWhxUymyLStfcRxVIj8JiSUa5xkGDbdvTdULAOXUqmK3mibNgK24JO7UW3Z7J3OaNogTAor4IbW
2RahbQIVk8yJC80pr9m3F2NPss1T0TMNCSa5zkxrfYIlznBPO9wuj7VF9uiTyGu3/mwVc6dvjdho
KWu1Kcjy83ZpdhLLUgg4p5/Ns4xmY/KVoHq4dxM9qh1dlBQnzX6bp2eY7GYfMP5ENrizZ1Fdg1TO
rF1iGNp5KOnQyHFWmWl/66QspZmzjIUestnYGQWIXdiTGEZo8+kPquJrtNzIht0nglsSjTpxYE6s
RNULjOzpK0xac4aGaUIGsmBj4A8aNOYho6m6q1qbuErozkCDMVLXDTfCw0YKxA3MABoa78cz/FIW
ID/yhPmJbpW85HUbL1uWQdiejEXFxACz7AaTCfkyYp+92ISY481TpumML5p2nuvtoCz56GWep7eU
o1jhNjPXGMDks5Tetn3tPddhjFToVfBvtgKvX8pKi9ASqW1nvHSHQX8CQy+JQIdieGYJM0/7BEqr
QwmlbJ4gBuo7tIvMpD6iiW6yHAk0gAJQopKIYkFpSqvlkccjBK7Bp/BrRxN7CBTI4LVc2JzXvZ3E
7kMywkXk+SSxAfvtCIyot4lJIqUM9aEeCnTdKpUaKQncHChSgCcUexeZtfcinbwye+P50JP4hovl
Y4ZgO+7WVJOQzvzGZHQkadeHc7PVUTnfVvhSIdGkvf3i5pbLboj4Bg49AnLJNq8iND/TTXjZRzqv
cALFajmJiiGi+rCUQ37ITIOgc9xn+gGeBJVrplWpdmPosqRiN27kc5fQ3pJC8hlIz7o9bdF5yppV
GkPfU1GnBhiG7DrinxL8/zbt/8IK85td+5amWNA8b1tl+Tf+3LerP/C/MC9zMRq6DI7/s2/3/mDL
zp6Zu4D5n2Ic+J9tu7DZtjPMWOHg7KbVahP697b9D3YTbPVNwWAOKwSu+HchsN+Fwt6OTZi8ocEx
W3XZtzOCw+/wdtOOlU2E8FMDONnlCfiM5byxx2GXGsu8/+WcXP8cBf2a/3onD/x5JA7E2cAStMbc
3sy7BExDSI5BXnoWonyDB3IjzQTDm2t+I+AE+PT3B3w7kfr51TAdkANjF0Ay6N2EdenDMSa1EcRx
lhx0N1HfmXbT/Dp768KpTejbVoMlqdik8+v+98f+u9PK9JSqX0YYnN53pzUcmR7jJA5KyJ4AJLHq
zgcp2q4MqCWL8g9O7d8djd08FxCxICZI75SXKQ67UtYVIrdXWl/ZOmL3g/9QezzS+mb4wG3wd+d1
DTHiAlJYZN7PbdF+47FiQa+ZfRzgNxsB66AHLPjOaVjB+eSlYV9nFv/1+3O6XiD/N2E8/p6SHxNf
GUNcxV+/vYAG5UD39KAJKNTPhf01fBm1TZX9PWS7BFsGMeOfH9FVpCXx0K3T8Hfn1Sq9VnuayIBZ
wgX2OorLfIgT505txbfCXJbAisb+g7mwkusXefNFJSsznAEW9j0Sfceg2y/TRSbXFUwXaz8w5y8B
A+gF5gw6f77peZIAjrLCy/jYRekeeylFF6tTUpwmhOO1t3J0iQ2sS8T5Mwb5nLoqhvk/RLcMX5wU
EMW2TjQm6e7YiJmv5Zj0qkcrJ6Yvv+HTUUxOYFFfG77S02GyWlF8ATiIp8Zj+x9v2pZ0wc6BgFKi
/4egj2Yqjz/JMR0+x13VTSsAuLzB8uaw4tKwI3Z5VNdnhlUlsF9TmOessV3K9nK5OPOOBHiIxyFz
2TMZSVWDGGpEVZ17Efb2dD/puYO4R5ZhxbQUfjaLbTWn6XCYawmNNrYLEyjThFoDrbxUA7bXsXjp
cj09wPZN1CERSfbZWWSrbga/djCT6Kak1lZlMojHZQ2NlX4TEAkZaB+O07wDeZu64yHp/WHYpnZR
NhvoFBlRydxdnthHAada6zlspJPafqyGNgWcEBorfY/c01OkFA8ZLbm4Aoa54stYC1ke/BZIBwMj
RXlfilho71prIJSwmBEZg3myyM+3njw1F9X9iNuhm1ls++mLXQlq0pqwTZedhRpyppx0CE/SCmTP
vR0jdmz6KcrK08Jv63izGGM7P0IAB2E3zoMjHoBOtJbYUD/pFlfsUpj86ZEZXbVLp7aM75kFVibB
A8sJw2CCRFbfLAULDdAaDGqnLQyFtAhxFQElezCyaHT3HXpqfDVUbCWANpR9k41XlJPJ5lNmDUhs
haxkuo+7ApZMnniQXTEMqZHnYInaF8wm1SGfmbYl8VlhjrO8xFlewYKjk6Nie+RkhksUCYhFRO1r
7RgPDHW7mZjXBFeAtr5CgeULvFk486MFQGi+8FzI6xdjY7fjoUuHoXlpqoSC5208ZSiSG80o24aA
hh1TXQkZJtF3s0cJvJXeFNp7D58aPJ26MVy2oyBdxodlXVohTJu6CSxHy/CRG4yet6w32VzOLsIn
WKbKfe1zSKlonVnmg1RfRu5H9vcQdthcUi6mxuGucJtuYa1nE9KArtjhVFByfojx/9zNzADTbcv+
eNy6NW55aJalccuUfnyo7aT53Eve0luxtEABtT/U7G/zLLzMXa0e7agND8Ui2AGYfcV4F72DJTP5
AxAvdYuklrNeBcy5aBSaQkGhuIi8qeL2S2dxG2M1/MJUd/5uwBp79slfPNo8Rr43lj9Rr8FnWjnf
Zn4dlbH5DX3Nf8mIlDyPVugw2s913+3X2IfLZn8OaYMvlHGjmji0N5Xr2N8ph3EsMi0lhA5oaw1B
PZ/zWVRuc5eIDlmQHQe71rDNslfbip16mzNfeHY7Sge3EckAAPIDyfWnJrEpzt26GO1Xmo4s00fR
k2hgvezKF6pxoxqJMV3Y+1ZhEvixhHKblXRPLj6Wk23TQ4PfFE4aGltGxvV9TZx43qqO/9mAyAjL
YEzq4h7oJAoCIoFBjWZjwY2LibRCjIwWqCaGXFFdhl2z8/GsjB/OLywEgxnX4dlIQyY/jhDJHUxN
ekhDUEaop8ngPNQewXtaJlzK6XVooIugLbufuySa6KqmW4frXcriqYWojJEWnFGxl/A6+w0uKaPb
OfZCDWjRlkV1HqZzU1xSFMsweSRWRW4Gs/5lCH2OJmXLjT63WU+LZsHXOvXcuo4/JR4g912hJaSr
wOVZE0LgLqz5utY9Zcs2mF99BgmZPeAi2a2fSTD/6tDCxAA6w90WBhU45WyjDcuWG6vJk0sbkSe8
A1BSLXtVkk7m8U5n4m2RSDqHy0Zpkz8+80AtRmY4gUQtAK7SqCnfJbEju92YG167Ag1lHP3ArBP5
XyIMHtGFAcs9PKHP1tJ7ifPEPu/SfIE7W1P18SJkO+gL3VDAiUDuyflUNE3tB5M9j811VjN1OOeZ
6ybciFUN7DHq/eIky4y2/u4T5LsweK4ZO7DuCaKxb5hmeT5DcpGXfK+FHoLeQy6AAR/NvE8kaLvP
GWUi1ieoeRHDGGtU6Tc9FQC9QvJzJEk4snvRGH7St1tow030TZXWAJIeH35bw7icnfEUrdauAhJk
RRLUYPWJULMXP6l59GV00Fhfoj5pX+M6jj+PY5Kcd65O6JKoDOOF6Up7IjwaHMllVHF6SIGNuFsx
q/XOk0lLRgoFaWaGwaH2oGANSnPZn54T0y5Il4iikpuW+QddAGEztQfKQisKHxLpfh+8BtUQ6hWg
TFxUzg5+ZvdIEbq8T1QZrqUS2vvezmXF84eRyLcRFpS9y/y2sbEiiqg4iUyvk/sRt/+9yudwaDdo
A5hIYERPDxhq6a0UdCCf22nvrb/3uOSnoGvrFlpivpzx+k+IzYbM26dApbq/8CGJLpcjVS/i1p5i
754or8+cvna9ZUcXLChC+jkGa0c3leoCGI4gpKHjSe90kVQEBlEygcNrMuHi9nPlUFxWNJezt2+c
rviaaMY5Dzy8Uc1plSLuIuoQpWJE/nqJmJk+oIP4zySkjauIZmt+SWb0JHhk/hDC1ZlPoDHjfV20
Xaodiltl77uoGondKdoqNktWeFhEQiOBm82LadnazPOxfmBgq08kT3nqSrh9RnLA83paDW8atq1q
rJTU4xA9YXSeLxN2YvywA6ufjQ1M5smqlXXZ4hmHJc1AE624okaTYmK1vMilaIFPxYV1Cd09wUkq
GaDsFfg9HDkF1PWvhC078FMJat+3yQPKenDhFuYnYcOPcwBVhP3EYLjRnbVeNmVnE/BbxpFl2oT7
OJvbaG8A30w2ZHsb57xBGqruEod414XOpiE+N5OJx8yGlHlt74o+KlmTgaEnyCkjboyuMtgWbawx
zbjy8Fo9gDaNCNIB6fCR0GULhQQQUrtj6BHGrNRaLDpkX+xt58f1N1cs5JyJIMysSP0ZNtAASl6H
vIpWEAL0IzHCvg1gJfIYphQtEfDJe3sGOtiFvXoZVSKaapNVUluEIu0ofE3tatAHS03ck0i/SfoV
RheEf+L+cKG++4lKQV9xid0zp66+GbQG8HUoItYby3RJvTGyN5+ryJyXs7LtXPJ3cQyiH9/7VTeK
6bFtKBNGk/Xt8XNSJNBRLcMv/C3TJPZO3dg5+6mMobFQ1Wic0IwXX1H8kj5hjS6/OsLVLiBpu1e4
Cgfe2h4uy6d5mKh3CiX9AzQU2/XVhOz0SlY3v/ENUa8MPa0fG2tO5ZaOWR5TSnayuFisdP4Ur6lu
xisOvdEUX0TEv+uJ272F4rexxECzd9LPWXeASAxGi7UxLRt51VrPS5IuX2GrW8T+Zjd58ahfpuS7
bAhuFiaaXQwAjQawrPGeMWI1t1R7oKbx05uUKVRpteuo/b1OitLEGdlq8wRrPEJAAkYaH14oIEeO
TnOK6cmfttNI/n9rsLePtnzO/Llve/9ajpZDDzyG5IFWeN7l8akN/qENrGNxvHkskQe3RZt2mYzN
zmfF6O4UuwuEV9XQBAJ/obgOzbWUPgUY+ADdbPxar531cm2vZ0VGkT0L0egyXNvtZ5esIUKhyC4c
u4PnwgQRK78c6RxIJxrOeCf59KgnoxE9qXVhsfNFbT4xIgboZVPjcJ4Ya5CxtUL1lTLN9qYdl+Wu
i6DmbogoARbwo4k89NzP1rlTwMnZ11rARAYubt/V4WpjqCX7rfM0nqQbqCbMQJ8mPhnBxvKkpNJ5
nm/y+tg3L3kzFhTBWdvetjofk2qOsihZOt11Y882AKBefWX6xLP2olIr5NLOuwsLrmfFjZ1Oc3Dc
R/9PGPzXmkP673aevX4uv//4Nb+3/vmfsqAP9QnQh69AFfkED9bgz8/4nuH8gScejYwWXHBJb3RB
R6ALEqghEIGQhpaIJPGnLijFH2QJXEVu6YieUuqf6IJv1TpHrhYefOkE16TJX70PrWUNo7SwJpSq
YtrKTkjvLfcyc/yzEvDkRcYGyNz+cmo+1Ac5BhxdwgBkWJBcODXv9EGzMOqurdoB74AGDhjzrGU8
CQd9CyJO13vHSpYPQmVHQMj/KS3HY+KqRVHC8bjCid5FELA+YEw2ia5MihEfo8yZTW47hSl1L9ZC
PQpLUZ4cKkx3jDajB1jxmG3nSL5Ots6/jbU1VOS47emr39mj94Gs91bwWj+dj8aLwutIQL0UDqMT
/aID2VUPvC+y2W5W8wKKomzVHIRLqz45ojLIOuUjI2inmvuf9+t/JYWJ9Xu/OS9I0gIHJJEiZGF6
VN8eOemVCxzcqDaIBwblUmjVhyhf0fk1zn3zFDsg27ZEWfpTD09DnOM79Bn/ytYQDDkalUHU75P8
M+SSzvhAlTtq0u8+nePz4RRZA5z+9jtZjj7ECgMiNibS9ZPFTkyoay1b7PM6g+GrmyJxT8Dye4yo
lZ7VgbKW6rXyqJQmGGm0T73TJTdFX2bGZdwmwGBmzBH1hx/TR6T/5TQy3GHYarIGUKj/jk3S9O1p
LLxE+ZPDyUid0MEPG+od3yY9zzKQNK6pX4B9L8BZfX0fR6P81pRptDYsut0n7ZX5xZxGzqPC583a
tBzaG4wq9jadKXJkZK8bddoMkfNgJwaIlZqh9Ry0iD3PvfZntG6aRraIZRmldREgiGDyKPm8Hmc/
n24wT4tvS1gpeVJbYc+gvu5pcmIkaZXRBlCkbd+kTICtna07OykZmcII2VhJXPlQSCIIlvtciP/P
2Zntxo1sXfpVGn3dPOAUHIDum0wyR82SpbJvCEuWOZNBMsgg+fT9pc85OGVVtd3/jwIK5bItZnII
7th7rW+txV1Go2vep35DDypJKeAixeKWAhpWnq8e/V6AlJXJHLxCZqEX3uedMRzHylDANnjV7RkP
U0+hXvEFLyZfYkYsuOcM2Dv9sR/lYN8uEIuW44orCelMe3E/VT3+qa3no16IG6XnrynqJwBoTcjD
4GWWm18tuVg1oTdlGbPg8BNXSc9pM5kTDLqEKe19j1AhqlQpyJogjOMaEITbXyMeaE0qu5l/G+w+
gbyXCHuoycvyEpxByQUbZ026fUfoVUqOpY0Bq74YHfcL+8jX1BM4NkKbYJooFfXIpJsd9kYQWnWS
xB+7O7U2WfU0DQoi6aAdA0ByRlk2QgAkPqvtoEf47hBEYRoG3yqSPTEn9USG1fAE5i06M/8ViDQb
PigDkKdTMjnvKO9Yp1dQ/Wdjot7fVIhdxMYMBpa0qUiXdIMRx0niIgyT6yAN3J23kDCK3GxyoLeL
JkARFq7bddRqiuclHY/uaqTchPZobrWaGaoCM8ru18AJvuW4wigeczAT69CQTVVb1j0QONWfkqJk
E0Q4Rzg/je6EsKt3fthxiMTZpmT+3AGTb2hQE1f6YrC0TIfEybxHKZhuH6F7BfWGrp++Jy8sJ5+F
xiYpdwSZibjpp/bYCSn3RqmsE6aIr3VtXAJyoE98XRWQpzfpJf1uMMvi21IIQQSCV7JWYSubLRjo
DXlGdTOel9WjP6DWb2AlzE03qmHv5Pb0xpi6uDb7wnzylVmzZwvths+wzuqAusy5gQVbH1NvHF5E
PyIHVTg9qhz+AWZIplqDapEeTHx/mrkLVz5I45Q4BrZ9RjvtQvZmmIaEy83rSgWBoSYmcjMEBG/T
WrfeVvZoYATzxH6xGkBSG6u8pMm0SD8OEL4Z3ya8KHbwsN4JqCue6PSF3zujoxJV/H32FENVP4Hr
dizSaYlxt/oZxwTxLEhIHBmLdZCPhUtHBt1nU7yUrVlGec+WItad7bPOcLlhG7MpMGMzDQXtJuik
vIjZ3PjLKB7ZbIvXfF6aW/gi89aDCU95D2qnI6zjqkXORDyhKdqzFDbLStt5+H9aVRZqhzxR9LuK
TMPd0lnGexuE/XXnz2s8WlLO26ZNspN2UT2iCBjL72z/8+1KCCt5qNh9QkzERnk392kQ7me/FREz
vPXBJC9qaxWBe6atXWxnJt3Z9YIYLjxXnVFuUdWhkRjV7G0HGyG91PkQbhtEOtQw620ZGj6vNbZh
dFp9btbES51rm/7CbkBTcBcQw7YngtMsNwZpXfEklH1f0giMODPOwaddv3XHVjx3oSStFX1JSHLP
Bc8b9rR/NsC+0Tx1RXAoiBsst6N28xOQ+2VvdpVQV21auUenMZd9kUHcgqU7DduMqcwjr/7qlc20
g/ain3Z1PSfJvaK5nKFCDno6G6vdPdSQIfuDsY7jPcaYDGJLnnhnATK5PE+qyeJpmdc7A6UaOGQN
iz4gHBV92NBtuYtXEk+RUoHeccnJC/3L64fEneC+HNvauK+50+URVfEaHngjG8lx4lFAMz3M2a7j
juXZLt2bwbfLbag9jYDI1FHhET5jl8UYGYMYTnMl7sgKPIJGeGqTwL4qSVHZoRbcQ2Hao8h8q6v1
QZrQMS35YOFH8Ur7dUnTWzRrO3fN73J6DkTQDN2t6+BhYHgbYBXDnIovznqspHetiFCkq0FI2lxp
mpgd/wX9Zdv5Df0pxrExpMD1U6LDedfZl4AXGRaHaRmsKMSneeRV50fAeIt35G1ZDOC623MP+jGR
jOoVO9Z8njiEz+un9RBech7dwOme26JPzEiZxiFb1nnYmfD2cfE4qslPvWA7B545lOexsCb6pmaF
h6IlJpRsl/Fr0YFwBgKWX5MqPurIMjJz59OOhJ/NCU3Sr4aYRxIbYU4+yjxNd6zPWXrMGXlSazkE
1RyShLbbtQ5I6Iux9gxPrcmiahfS4gyXdUxzfEwems5ZIxfeEIL2DAehGVpJeqqbwabYVeJq6pJ1
56MaGfbUGvoSSCcuAZV6viGMOKTlEI66vyLWe47zyVzlFvJIMTHZmrohNi13ojHZi5uO3TXdSceV
tADIx8TONvukG5lqXR+KhHPOMigci7hFevLd6GchAYAwjhHLrtamqFJ72jH49T7xzHZXxWLCZMKR
iCa/nxqMbGSD360sQLvCMZYmnoa0+hakyrmcIx8GnUWsjyMXQSO9zQuCpknU3ihdDy6usRp/UaAN
9943MBpXRVh+xxVmfOpGmY8xW/HmOGRpmsarW/bb0vcHduWl/Wn2nOCPDPzmeMIsJRtUBLnbHlXu
MOxAra4B1bfdwW2mJsJQE0ZN3vW3BAY22YG3SXUbGOH8me6DfHAL0Z+W2gzuJ377mln+C3K/4eSX
rn3dOlX6bC8amk9mK+sLxENxvnguDmlSWd+LwfFpD/dD3LfJ+MaZFZ8JqDHPXDjuGL4eFsu6tw21
zSvRv3hdS/yBN69OvBAFHS1N/zqDiI5XNnN4zEd5GOwSLWMp6zni2acKqFyDNJ8xrawvsiSBjNhH
INxd6yNgYiiBws1pml3pEgvS03XcEigwc73n+eRBO9uPnS4jLdspTrD2vRQ+pd+K//Fk1mlnMdma
uZJj6Cw71xDIeGer1FeT58ChgwkLgpWe0EpKU2Jq/3UxyTUOJI/bmIwEKBTp3kVcDL8xG/RNazln
Aqzah7ESGl1a6kxHPc9p3BkyuNNCWaSI0S+plUVsNEKxu4XmvmLP1IQ7MlWbGEIfG0ww4AZJ71/Y
m2JfDfV8H/LW2MMBNZLYh3Z2mzkNklBZwBkTDlsiNo3dt4bpyVVtTda5743hEzwW61AgSTvVIe5A
W7fpHZz4M3HUtz622yvMukyC2QGcUt84NmiO//CSVn8Vydh+ImdN76vKuzcRqlDFMcDJ2gG5lsnU
2Z+qq34Uw1aa9bDJLM/eWZ01Xq9G7UeCdh4vtErv2qoWJGyEKi5MFL1lV8snR7NJb4nz3S8Najy4
Fdkmz0trTzzXlV9JC8enGm/CktQs7dXZ+ZIKv1Ud0wzLmYdbPK7JURMexFqrlzPgcnWSkzaeKLmw
fwLyOU86I2Is5HJz3TsyorssQw7Qu/bzQpblPnDkekbtr6NmFK/MNchfZFQMi7KeYsxC075MnPcO
A364Y1xVxzmG1HNnoHjIsoHWVbbYtwZhak9WNjTXl7bhzBsq97EYOpTTBF5vSEzQu8DP1HmROPtm
Y1kOpU9ojDTG5Vy7zfCUreV3YtWGb7UOyyid5pDMVju9eCuwT+ajJnguLSrSkRV4XyZPYeQ17VWd
1d+WpE12FN/NGZ8PnlX7klTmdM6X0kkWQPIyZd0ZhhtMrgZx7oSfAXBn5OwUPU5NKo8Ew89m8gou
cY432i3XewYg9pPvwv2c8SntKt0xL5dNF16PxbBumhF3/lB03AdOX+xM1t03PNbBu9+jJ0fMzHuG
PJRjPSTGNWYxCGODG3wKXawCW4JuIOlXcozxYD4Ha8qaK0S9SSq8C3BS+hfSbyKDvMuTasMA5pvj
sbeCidozhzVrdi6a4Vs/iUtVbMaEUK5XifSsnVbpI9dkJoMAGUeSJbgIQ/0c4BmkOztXx3kx7wac
txCVeElbbbPsqtrfZ2DZYidXtdx2sDfR78ACNW3iMQNauLtGE6xSluxjLN4tT3meOweDUup4EZuw
o2uct8oz61096gdHSYFyASnnC1mIdwQlrDtC3t8hw9gnrrYFPCerj2Ge70NJ0GTfgSirZg2aSLB3
00b9SL22HkpXVdvMtnmXzvmVPQpi3ZrahbubhIAQw65a9hhboHqHvN5THm80x2Gyozj+jCk524dw
x1/qwg+vIUtSWSH2QhO+jjv/EskwlOHrEAaP9iStrUyKfiulNW4tq2qxgSwHgwdo02jXuZoxs3xr
qkpDoA44BXM645PS/QYKRoMYvIITqC8BjckiSWYjRplhcG1S1IgsOQgGlQxfVmKWHRJEcjGi+U1T
LFWTRPELrmE84tBCW44RRjH1UBOXsCOAbOP67Jrcji0CIZ0UH2bVvCaqfanmOfjWLao48xfrW38Y
0RYl3SiIL5FEhGaIJ/5Ix9Y9eXjebhC8LF8xj/d32pLzsEn00h1MIb660vTU1kOxfA1nw/1auaa8
I1mzODFLcK97u3Hu3KF2t2bL9gK5nHnPhlKcEvKz9xJB/AkMFVjW1MisY9NX4wmXtr5W8FnvIVH2
N10e8suaKIWR1KlHBfmT3oarv/TuZL3WGhuJaagRG0+jCYNCcbwcwrIpnQ0xvyEsR3/gX+wEBqfT
MYFp3ifpr+Y3jPRYv8Zg+eZwh++1COZdD7QPe1sGtxRqAzhxY5Rkg7MJiqHUME6im2qpyPR85pPG
POcdbqDa+eTbRGjFSSsoOpklvrQrxsOtz6DknUCoUW3HpOvuB1kVzw7+w4AsqGm8T5jInebepxMK
sumNUW14KC2LMQVhU6e0Ed+MvIKbiKycLC7Hf6Jsf6wmkV9BHUdi4jnrvQ4c8wVlRxYDdhgPyEiz
15LsnHd5sRWjv6fM6nEnV+ZwmshSvVJ9Q42kSvkUTF1wbxILEhfcNIewMM2IcR2CEllM22ZU9r5d
UuPB1s09SNwscsV4P7a29VahC2Ms0+rrctKfcUVV2KUtE8ZkOxvyFfnpZO5ZkXrmQ3g5I3ZJIkMJ
NicHsOzyj7kXXUSGunFOvQLXAidcbkYzva6tgZlHZaDCynEdnJxm1g4Cl5pODlWsu0uCivtdzShu
sMEGB7X05BPJainLw+SETDzXfp730l68d197a9yhRr2WaftYO0QfvmWKUQ1jVls01n1a+xP5QLQ1
bqfyIl5jIKWt7dyb1skae+TZpHraQdyzsLjQpMs5e+5oP2nm2xK9dyi9ZZdUevwSUniVu6nvwn2i
RoO70F/t88WTez+VPf0l1As0zxbg1FhiUmm7pH35C9lDB6f3U8afU0V1XC9M3M6im1AH2X25BIeQ
/DZ1bFYaLlfSTumlIQcE22p1woYUfQF8FQqrH9PQKt3z5ltyMD7heMdy2pRfO6UB5A8lwYyby00r
/iD2arBugGdU3ndacCVZLQRnATTmhCsWz41RwVHeYbJgy1d6vbRuXa9C4XNJTC92BVXLtwn5x5PN
hiCElz8+AC+ck7Pv6upZ1X31zO6pqyjtavfL2pfeuM+bQKw3JgqyfJ8LmcVo/t2bkaeM7XlhAyro
SOut44Vd63XaLvNwJNSTcKZOJcNdj++iOeGQZdQONzaPDLeprwjRMhZUD7hktn5LJOK+wfFGqTml
95lI/GrDkgBJYMjyWW6bRlbfsfmnzKKR6YtPYIPA6bbII6k/LLuq4hQINnl5gaW6eIBfAA/BcJ32
xiLBEgsJ+iv68HQmy4PTeYwQetvmzzfrynUdYOiam3Xo5rtpnXi8SXx3kUjmONZu5wF3ywYRaNZs
S3p5T4nk9txZCJ3Ii9OD7uNyVWiW1zRzp62PtzrZZBN6RixYNKulhs6xa4lJLLaFbczXXjH46za1
/PGFiYc+TCU+iQevxVldJeCvtw6yqZ73Bo/VI6mZwTVVeXadQnkl73yc6yxqc2ZP24EbwtzmVJ/Y
49JS4y0aXSLsraAkzanSBW30KYRYvVmtch2jalawARQVWBS2ufbvVwdJCTq7JPeOzpQ7NDWko+9S
xs2cmQYvRu2tJdrRQpk/2LIeHaeimZ8KBC1UyauHfM2bFl4g8MZm77g2OoFTY9esGXMrv2Vub8G4
YcP9WfdJdjcQKflN+dX47CFWogmOqMQdTIuo29ZnxIqBD7tSU89475xEuAfhJdZwzCpvDo7MyWnU
Zvhb9WbSYrjC4oIajLLqzoZeI7ZAkKtnh/r9ZbHn9SZsiTvfSsRGOItVKz7htCEOtQ9nn3fzmPlf
106HRIUS80k7oglQDkt/QnCimoSCvh78/PsUTvTsrQzxyWHQLiU/Deim3tGGGcKrlPftHkZHJjek
LOJ54ZM7XyewL2qDvwaPMGmteTzOPncfHiJ96uc1/8Ne2/4pSB11Y/VluqfPwC1jgtgKIkX9mB6U
Emt5XtH9gtqWaR5EgF7rKsrdmke5WGvH3tezSWFlYNy9E51fO+cFFAveINTR1dGwc1JHjanzeXEn
6ZxEPu34ZZthfj7PQLrt24DoPYRTuJmIglLiNObKqU+mR5UYs1fj5tYF9X7kidH8kotL2UnQmH50
VdY426wdeSpQVZBIGIy1cVyGSzq7rnxKigVeMppPJHySLbiHBsgjcyVM5r4+kIdX3gyBCu3bCyXT
piFhUVrJxatJOfZdvkLPUzltPWmwDSQLnPvdJIXtfS4L24tdtnk3Fwm4E0kIy6dgsFoCAMa+/TII
7WBd1rBCkSyo6pF+bvA1h07+ZbG7bN6jAK6ebYpOycNaOs+rSS9gQ6ChSXP9ktwp1TzdBjx+wIcb
f36xYAmQvIuXtTiSxdqwsR4MPqFf2yVSorZSAuxPgi4Cv6d54/aNeE0mGs/AQXhAx1Rx6TJrNrO9
r/Frb/KJspsjhoRrOm6CVolhv9yhlqd6LTqyMxliLjIKXde9cdFCptuxMs09MewXaQTJ4DEhDvgM
805CTGKLkaijadsIaRuCj+e9KVZ8X0OfMV7B9O5WcaurhehCkFRtXPF19IaFq/Ljsba72yYMWfN4
CY8RfY4ZDnTW183VWGh9RUhiwD7Rh3z9h+fW7duCPnQAJuXay1mwP5rvh6xJKU9rbXc4zoDFRn3Q
dp+08tFbdUSGlQc0rsH08GOMtUBkqZFMo5HZNEzBXttBhzdTEfTLbpjtAMkw70jGtqFMH8tisu3D
ZFhe7PGwEfqbjeFzSXpzzn40UA9hTt/kGPS6aWNUKe9DaOdbp02p6drcDY/ZRLtos6pAPQuRrHOE
eJII67Ykr2HbAlPokT26+ipBPit3cmjCvTACmvyKLn9zmAabN0PmQYrcpE1zBRq3Sc5lgK/g2+gP
2XJXhKpLb9Aq8/CKmgiKK3Oe0PMrGiX2eSj9Yj20k2KWyP7ZqY6C2Ps16qBSDVyguv+OfzFVzM+M
8lk6nbmcNWaC5LO9emsHZWFOKvQyVq++4k0p12c7uVQHgaUJOQTVAWAjoEfRPULogYpDdHkssV2P
W68NMjeiA4SrxRvo+yAi5BliiJJnx5CzxPYSuwn+OOISy+zVXbMc0++s+xrQTDEUw33d5fanlRhK
P0b56sw7sx2IGMdIMIrbEWM91Rz48mAyz2Vj2Q8X+dgOs6L14hPd8UZWWnJNAKfF9leIc5+n64sr
Wtzk7TA8+OnaHuQSiI1IPaY5ygsOJeXSbUeoQ2RLy5So8VY0mtriSLY0R4jdwn/EQqTeyhoTI0qn
3N+bWdbdMciu3i3ZT9+HNQVc4rD6RGs1dQ85lvHwrAHonD2JwDUySqSaJEGTGq/TZHnxQQschkLG
yibtPCqz1f8yg7P8PJh+SJh1m0a+4lbwy6yLCiMV73VeB8QeO759PS2FOoLtNm8zFzjjIUO8YJ90
sgCHAuDVR3lbqAOLgTiwrepR3q9F+yoz6bGAj9qYd4uJxt0bu+yrs7rFAZczHYBAh2fPceeTQL6x
9SwjPC0ZnKd0Lv2bLJR27C0KIsVcr6SJu7NA8IUU09rXVbY+ZjmIMuZYjYnYrKfBFSAQPlR0CL/a
imRBCwzHLU8QlnP/4uYm5GQY37RDnjLjBsdi6j0VVwrYp40kkduQuXTehBcKXb+bwi4sY4xD2e1K
vzXd5JKs3E6kaP1xbpKTYhPA+riKKvvOMJvFzprYsWW1aRZbWsrS2fZ1Bph+yhQKKrd0Y+ra5qSV
dIaoI8cTq+vYclmtclvAmDwuIVaagrySz95qVdHYjf2Vva7E4bQVwzEreREBza0jcbEGznusKCJe
ES6/LNr6HhAVcyPH6ZN/kY4b6HbjhY7WFfPT5XaWGUAbw+3zh1ZpAfMgINCFrmex7ZNBnODXMHZx
jPEpA6nydSEy9MpCY3FHM5Ubf9VdszNFb0az6Lg3yEW2QXkgfME7UYVAHDDRHivfdInEmAy9wzNK
PGtYm132WjuDcWLwtg2mXvZbo8j7fbZqtNUGB4zcQBfeRrM73pazeDTnADEg6s0NI+vA/+EZONic
M8bVbPTv3BF0w0YKsJfAR8MjG+TqmYlDjdkLm85sNPBbRBLkzhaUXXgusBF9mfOJt5hesha/S+Df
5GuxfA6J0Y3RQI+bggb9S0NyKR1dxSs1b3saFk6J6HI3ahpZ5HdUZ2HwJl8am5Dz1LT7SBvyu+Hb
00E0UlXRRSO0/V+ZBi3hluQYrUgpBwzkCh1wnyN/FnlPzZYm7anIaUoNNmkvVaCb+NdypZ/FOWg7
MGZ57AeQJGCgxNb5s7ajZ700G5mx5hZYJDaYOcV5JUnvTQubeZtZ+7eFtqksf33Yn3VZPw4rEJSg
/TIB+Pjiw2FR9RJBvKBt7RvDDzY1cZtJVNHzZkmtoV9sCBENfnNMy7zoff6juOGo+E0RdV7sqxc/
6keDISrfEEoQ02c1uZduZoFZ6JibLF4bJESq32GWGZ/mRDHEtaipUUMExYGhPzu+qfRWFWeLZ74u
1YBDWhm5yebVH2b5IrB1GUfPoGMOdI40WfHKuJkaWgq3+F6TQEPizAR2FLF1Q32wkGnz5kPmEbtR
QKPizUzW1EFUbXNf0NYgJrZanZvJkuOngF2u3taKsva+7T2sDLY5SnXIxnoaY1UgFI5LnYB+sRRZ
Sxt0t1b3Gi7uRUJiSDzaHg8drTISwZ6Q9TNB7QplHM0EBgFTJd1dTNvTeoRP4j3MTlHxaLFXeNWz
5l2XzQE9WEqrnWNQXG671HXcCJYx5hH6fwkIX3QpOEEyBOHHIDenLFqGZjl6lcmebRaC7gcqH3my
So9UZYoy56VR+cW5JlrjvW6CnFpjBl6zZ2KVf/aqxhb7vJjIjgG0sLxVAfxPqD7z2OHcmsmAL6YZ
YUCXrV6EQQJ7CNXbzBJAd8wgB8cZu2NVKwn+IyxpHId+359hdPGaCVZdVEiIehQv4POXMpIyJOoH
yn+zT+sBxRwBqw4Ge0+N2M51VtEWsMqQ5RvdjNgs1difXKsi86ibl/UowXzN+x8Px39JZ/rUom+o
//fl77y1+P/Bjqkf/uj//Oo6f+vbof2ufvmn9u/tDcbu4eMf+uknY7X+16eLvqqvP/0C3VGulvvx
vV8e3gfIV/92aV/+5P/vb/6P9x8/5WmR7//nf761Y6MuPw1sxE9mcx9h2f9bhRojOml+hspd/sI/
Zah28A+iRxGpmdiVWVgs1rl/ylBt6x8+jzoPkWnCdLNcBKr/TpEI/+EFMFsIAIBizN/5jwpVkGaK
mJXfIrmUVQOb97+/9780oL9yp38QaPosNjaZexwf+y3RVeEHBd1qSxRFeWExPjJtWETDH/JS3BnW
Kq7UuoQnpDeA6x3C0wIIwGBuMAFsfL/qJFwUP4wEs9JT06TFpz+dwn990l+42S8fDFm1zQeD/hva
wYcP5ieFUeCOMelRye7cKGZ4G7ZLfNAS9jsVf/UbOeGHJZgDXpZeImCoK4Tw3YsH/E9iUNfU+G6Q
o0W+TMYtOoP+1GMoef711/rg7TbBm9qcdeobsh2IAPkgrVy7ge510AfRGszOfk5W6BxVl5s5RYT9
qXDs7iWp3Ia8ADk+/vrQH0SniI1ND+kv9SxU8Ms3/fANE/QUU+szwnVWDwctkJbTsCACZlwH3qKv
nGZfK0/vAP3XGxKVGcuu2UjHglSTmwoSz61ymuDzf+NTkaCCKiG4xKJ8jN30iXwKHdAmZHU5xk5w
aQ6Yk6mqpiTMn3JMWWe5+CWIHf/iwhynF4YM3HdWeG+MgIuj3gFg+pub4WO4yo9zRbwLJGgeEMv+
8ft/uhsCrCL00Ru8ukgEd7D/QAkBKPk6t0DEa+kanwmvGr97CHX302TeF7SKzsnsIcsaUnX+9Tn6
UJNcPgxQBxYKHlCwjz8u7J8+jLd685LRG4hFEfD0FVk9xoTgBbEvTWy7Ilx+kyrxd7eK8Im2uUA1
UKh/fBhsOslFnnU5k7q22q3z6NuIpHvzse9RjGR0AbAsaU3cPBvvrBiYAkrBJsO2cKEDk/5k6nn9
zTX5UBBezgL3LyYJYhjY1Hx07dPPFZ1dkR6XoAe+71Uyx71pT+hukvnQ5Ki6/J4u2a9P/cdVwbFM
ZHwXgbjNQ8Mq+fOqYI/SGUNg+eyfkpRpOyIMNkrtb8733xyFxhBaawH3Ifxr0ekZqC/LpIzncuCE
epdA5Wp06odff5m/nEELTIcd4LoinTrETPXzl2ly1oaS+U6Eua66bu3MPTZeUo3YrVWyX0ec/IVR
e3e/Pqr3QaXN/tNmEb/kcqN5B6HxoaRWEIdFZ+Zu1NarkRyMTBjfXWvOml27dNmu1haWocWpBHMw
o1964HUtm+h+he8Gv9DAz2XwQoROR0H0WCLGzvato/1tsFCnbgdh62zTu4t86P3G7xgWrvNDUYj0
ilvJYZdQWPdISwYRSwXFZENe33CVro41bwsm00iza/oeWYDYnfa1Ze8Hs7DbG06jQGU9ZXOskHbu
OsOe0Ekh8SEDKBwIG0EHrZ6Z/3k3pgGWfgd3qz1xn0DIm/1QE0JI17MDDFrS+rZHn84mACumUlaX
2uhRiTE8VvbkMeebmvTAVrMK9g7Q+HxbrlP1RQmxJjFynuoZ4B+aqqA0jCmyigw+UWLS98XyiJLH
sIueNklt0v6kwhxkmDwygOqeK7fA2lb3zRD9+pr+3Z3EcoTwn6fjQpz5+U6q4CRgtbLZgNt0RNu8
SqA5BrT8QKZGDm2cm6wKfrcjvLyf/rRJ+ud9xIgOBgc/iw3fzwfVaPFGHOgiqp3ei1e7DuMOijNm
P/TR/+XvRyEQciSLf+yP+QMXWgf1UsiheCrOZCCZuwTMzVY60j1xny87ZLi/i0H+m5PqMWYGWcFa
76GA+vn7VWk6JfNaehESTXVdLvNtksGBpF/SR6ZPUeIp8v1+/UX/5px6Fus7pBnHtULnQ03Quk5m
pIvLF4XNsAu54FuZB80Oe7V/+PWh/vIWs1i9HeoO7FMuc6YPqw8l2ziRyck9A1k8mhYkfaQt0Bgv
tLipYJT85niXyvrj/RLAdyEsg3kcdc+H+4WRRofKGblU7SmqGuIVvrPLql7zbM2fxrK2/3CDZtR7
s+0tGrytSBFKpIkWoAGId8bPELR7T5fkiPKAmXddal2m8c2wHAdEk+o3z9TfXIqAxTGkNERUQPLF
z5c/IdUBzW7rRw2wlKtxBPLfyQTIoRzm/8ahqEIJarE8luWPvZVpmgagKanPgIwgSk1b41gYBFNU
LMu/uQp/dxHAT/DIXpobzg8Wz59qlyWzactPhR8Nq0iuxpVt+cqrng3vgLdBq6o4Oy4OhV/fa39z
Lpmh0jhA80AO3Y9+y5+O2oZhPmcGkuPRL5u4RHS77W0suWM62/tfH+qvtzX7Bsd3Ayx1Frjgy9vv
T4fK5tVnUDN5ERNf2g9uouJuRRYDVtmMcGdVv8EXXW6Dn1dBOlPYBx3PErxPP9Kh4PmVdejVxIp7
ndgNxqKuQl6xv7lD/u5b/QhgcS/Lu/cxPQmvgSFDdxBR7i3hFh7euHegSJOtFbZbD/fxb47Hj/zr
92JpwIx5uV425e7P57EqGWlVdoPY25sMJ6K32CiaXe6E5Zy2boOEHsEQiSCZPA0zeQobfDQelpmB
Bu8GwnTx4CcYHuIBkhedFFIyn9p8KppoMZyk3OpKAKMkFWLaTJ1yDuGq1qcQRQxMhEVWb3nSLvss
d/R32BHtbTqqyt51/siru3IyPe5alJodVhKBgtkvu/xmxtL4ZS5M6hYGoPUd0wO6MY0Yqs8dSGgP
+hoA4E1h9uN71iJ62EySBBAEgbZ+BQ2BIDYE6HVJvyu6M1sz842BAwYkLn39aRjH7hMk4PI7WRbJ
TULAAo3BifEBTSuFchWfV1NvS2bIMBsG0kXxH8wtgdCuSk5EzovLSUyWO2Hk6E9Rk1QJUQf5gnWw
zvobl74VXXpj9MEWlSvEVEPl/tkZS0gZITq5d1t16JKz1Ku/elJ1dUx2o/3EbmF6qcqF+HZwkFZ6
NVYOlNoQhSIz1B51/iADlygMJAguA/9GvWST30hMWQ7buLm162pHbP1Azx1Nf7nPEVpTO82Owklg
MMbcYPmu3yCCGw9gvIsiagkglhvC5zmFI35D9EhVyv+hJhRvNQKF7549ab5XmafjDqBH+lCRAoIi
t9PytqfX+EztpmjUJ3jWGOausGYGEn7XTYddEeMWKWTMRRCTQ8t3L5joYh3wVeLzusx6cI/4VxUa
h/E4EvnxCWok0vsM8js5Nd3SnBRqO2Ip1iB8CEmrIGh+9vTZtCow3LUF9H0rw3DgtOYDA3WGJ8mZ
KzhbW8pPBHYL/AY4ZKmBD41ryx9E2M1Mokic8YbkWTVuAWD6T4XZGJIBFcBPLAl1e8RUln2zWzss
98RdJMdVaY+ea9E1xxwhebedAA3dT95qP3EgRBTz0LfkRTXrA/d1zrg9k9N71/bhuC/bmU9r17zk
NgJo+K1Ht7+Kf71Y/nUrQAVBOzcI6BkE7sfFkt66havRspExm2LfNQxXeAfb16PH0IK6o944ptaR
n6DQ7PHt/Prof93WUs3h+g4s+nEhe9sPht/GhmFj160dyQYN8ub/cncey5Fj2Zb9lzdHGrQYvEG7
O1xQMyiCERNYMMiE1hcX4ut7ITK7ikQWk53oSXdP6tkrswIR8CvP2XttCKb1rsn0aaZcVVSyrWqP
eSrctbZCEbhtvGvPLJ1rnR9851pdf1FpqJ/+/qX+ulUxnfGZz8cUjmLWvN6/2T+EkuOZgAO0q12u
F+gc0xuFWB+KyF72z+zYVIDwvVN+4h9PV8VxlkcMLy2NznQE3Fnd7k9DKcfdmJTFBaQ183y0h/YH
rvBiJ2FOYAiMFZ8bSLkdXWyhtQ2kxulGFirXLPZ//w3+Oiww6Vu/7r8qRyB93hvefIMxk201icLZ
paU3ntSuxxJjICTZl27F8pgW3MPiQNvGKIdogkf29u///l/LPZidGRucvLiGu5Qb37/AlFQqOt/e
3uWBDK+qmKWfMmB1Qo1JElBgd/vJYJcBr+PcgI51TtnUwawNYDF/V6opf/r798GHwh98t8tTMAZP
4Fj8ZrO5eXFYxlU4KIY0sFtMsjszo2yCODQ3Ize1EeDHU4cx1g+N03VXYUjc5xYZXQ4kibPVWcho
fpEjNdOtB7r6NEDFYnQT3cX0mgBO+jVsOrENLBoPJ27PrHoFKp+zsMKHhLqxxkZVhYb1mOLgO+p2
Slp3odUYBHN0DUd99jgBUEOMv8F4xYYa6CyX23607K8wTwp7q46j1u4scOoB06qLrzISd3DY64h+
NrmbqhDHwMf/rIqB5QYrpzqc8gij2caxmv6hNGt4Za1SKfG2At1+0vgdngxkQALOdFjCHa5zF02X
Fbf5zxpDXebnOEDcswydPDtcrLhaO8DsRhFuQhZx9GvLqFqyIPpJ7LXJqK/R3td0eUEOhUDARnXa
oYRr7luHqoLf6TDoj72rE3UnLPUyp79V3EhWF+hDmMQBJEZq9lh3IZKqgc4qtpKC2he0pbbY1YqL
VKaM0Zlsh3HMYdcT9XYzlMJ6SUq3UA7skFn+mksM0/fxxMR9mLzI0o81uXposkf8sb5RVE5HjzVo
TxNaxKuhrWx5UTuJZ+IuCqZ0h/K+NE9JL+rmMEYijfeOJRvtVk/BQinoG+pd17hqsJlLzvHW6hDV
bcusBVUmaw/uHj26ezUcLJdSBg0Hfs3QroFNNnDsyrjSgPKpgarvG0Ntf0ZB0N+yZYc/HQYREp00
xnEyTAgjPI+oqk1pojEGp8OWCciu/cbVsqOOhYMvQXcW18HJRWoqNnbbS8p2eUrRAAEHuc2os0z8
sZG4xww7bwLDmB3EWLpgiorcuS/r3iEMDkHwvooRaGxLx6BZqrYB5nOhDJ26B1Oe4jRp0wpNtClp
Do+xixoCCi6GhkBE/aZAS/HI+aHFd07r3wVnEOcjlXhKofsmi/MHYZRKjrcKQTKjT1avmPnL6FiZ
VUejE8VMt43tNJup+2TqHeossi6SqfHwMcQhxkvYdPwdZ1TaY4FdGftkOeqk7QHGPECzQykhpl52
OwbhUF0MbaA+RICvwj19EOXZ7mGFI5FBwLhrptZKj6WZRk+hNfQ4GiCNYd7xBnXnaJnxNBWj/a0T
3UintAtsEz8ozQQanA0HRAGXSZ3vr6hSR0x+NUOqGL73CjXFnYGw/mlS8LZiFmekbaCFlIe6GeYz
Tug+KaVC/FmHxwKYLnihjmNrqz50rQjbmZNUnw3oXl4tp1Vuw1ZFyl1lsXzWbPIL8FJk6re09pR7
OcR4Hzhf4nIVBhrDmIoNNoIapWlvy+wbiRf2k9S9juCBJP29l7a8bJBGAJxoKzIacpK8H9B4hc+Z
cBwFoXrXARJIhTlskW7qJOtQUkC+XNDb9rNag3pGMa4et1yxwQi6NrEs2yAYHdBVzkBc3dxo8nUz
TNMd1mmcAkaXadcZx+uMWMK6zA8FF4DvMo9SZ5ul9XjmorhiWpBZqp8UBS+R34kCCY3uxu7PdrDI
I+lTkQ7nTgb/bD9xx7wJhrp/GvLCBuEH1PAh7ULrrK1rzdjpmZyb3NEUXpJoSUtXSx1ELjWckYxI
uRY8qYZQqj6jTW1YRzaWJtr2Za8XpzAb1PhUdU6t+KnM46u8aOp+2wjuglvCOVzNb+xwymHR2sFt
VZXloxZFQKBi4kCAmuqyfTEUhfXMDRPlWrJKhlT3i05uBR+222Iug+2hQPJ87IVCbB7AfKU5oGvF
BhGDcX5UA92AeDE1hbcth2pEx40vc9erCEyQGoFvuHZMgY3U9cBAHybPC383Rkhux77slK/80k1N
i8DIgUhGPQduK8xsia4IeuxGupr31HFbgA8aJqmfuAlFgizH6+x7aYdjFWCn2OKMyV5ibVIh2ChO
+lWoYX1bq/QcdsB1i4t6jCdC5oKJcJu2M8ltESY4NXIgBCQL3JW53KB1HIBI6KXc6JygnwKtnp6b
CIH/MSoLdlEhjbTY8WN2F4OJJXVnORZlW9hqo0NWMXGdTmMg6RPzOa0rO+2JHIWqOSKwtUOcV7kM
dkkQ9+aW4Cn4BUNOH+GPI8s/asX/7/XZr6vX4k40r6/i8kf1/0CznSrkm9PS3Mz/s0k/qwX++79u
ykZ04Y/sLfXp1//kj367MtPgaRLh27UpylD+4bD5R8MdTs1vugN2x6XfqJvOHDz/Z8Pd1H+ba4QG
vV8dngyHrn9hnwz1N+pR4MXwJ9CioV72Txru70+6/AWNtyMmbg6k92w6/+8Pmvhis8lUqcqHCE2v
omSKb2Ub1GRthDGG8RiVTmUCDq2LNL5UOzu6e/Otbv44Qb5tq+vzH/j3wZIXMLl80fC3UTnxGste
Yo8qnRwmyry8qfKgzLdc0ekmf7UYTrLJawhEI65KU7TxlZUrXLMHulP+5EoXjwsLyPlg2dVjzvYT
oCRkLg9Gf6+HiSRRu8osuW8Kxy9oKX9SaNP++uru3HLgp9VgWVG6fP/tansEd6uX8GRtIoKOoxpr
NkwCDohA9nTnaaxR5JO+o2j8m4JJj08oq7X0nONlG3x2Y5gP4O+/I2wkhBiINOhHohRdvMw4trg7
DHT+6dBjaJOdi+Bo7FJ1P2hR8py4UAcdqjIQatN8KvdFKyFKN14u1MNQ5VCZS4sL2J4lCJ9rRvQp
mxgIG+8AajRuzwE99PUnVbb5GvPupWmgoqpz3LkjRz128QUVcKJZrVNhQvyEQzIsOs0+0nWy3W1V
phRt0iKEjqmFeP/Q1aqowf9++C30Jgw/NNQe09Kg5zC/B1P97U1PTklqaxw7t7A1IetGlGLCbT5g
ek0NsmfZ00svic7UwJTKTY4Fj4Am2ZVDKFho7eBLqmd96wszQ1FvaJkLNCShWPn4z1+TmWLT9wdf
ZvyFz+XCpEQLDVeYmZQOmwIexp0Kd3xfcSOCOq3XAg6X3pX6MZkUPbqqJgjQB3BmFQmx6lQPfjs1
7Ph2UXMsgQba6590pn/h+N//mBQN2Hkopbizx2RxZ2WY6yOwi3Lr0bloroGdo0pN4MOzJ4148HZW
NZb7Oag59p0xdxHGupmEDIAO8YgBVHabkMiIswkFz3Mb9fXerIa0P6+t7DmpQUTBNkibL6WFYR1N
rSUVOhOKYu4ahaR3TNleaPrkJ+byuukReh+wZtnBw9C1/YMTWJDa1c5p252Nkjv8ZCAvLuzzSk0B
w2MQI1+irbQs8DsTpeKRjupWhsjFt4DMQsIsVZXDb4/tKiFhrs5ICOvNxO9HHa+mK42LRjQITWQJ
cXcLBlZ3PnktGumLGeawshooFQxa6fpshXw/vmtP9B2w5JSw8jJzEDz39akX45DsvL6si+dEp165
cQJsPucoAU9F3JWJn/TEEY/CvcHPBtpKk0N/cqps2EoJS5bm7iOH3/5+NLwnr7CMU8bhAtdV3hFo
je0baWrTDLQBCm5Ac7SkoxfXsWZ2SIBhQJ01bi4OBtAl3wWHfF/K4qUoAk5QTvaQAem9GpuGuwmX
9sRXuNajPupxaiMCBxW7LTVT3FWO0XNHGn+XMEg2RFp9H9QGkSLVtOqcrn0b+KhiKBY0UbbTEWKc
I6DiTRA/7zGkTbPiMYxe0kbBsgDUpJmHKoaIVh2AJihxbV16qFf340RdWaescQay/cuEcO0QGqp5
nEjGu9Ps8K6dYF7Ap1WP2ZBMl+CrazxfAT4GEBhkCQ22+0OZy0RJaESXQR5rO70J7O+s5Wet0Zg7
Ula9I4GjIXpnvTgbaogCEnAQxzRBKWabWaHMd5BSrK+1HQ5wSpQ76vOkGyeiOGXaGB40yFV7GHjN
rkZ1uXVE33+pSv3BA1t8rVdIEKCjaki+uYtgGDkg4byYq7tPDSbq7400Q2L9VKq0ZKyKST2zIPtY
Zx4crVekpPVLLvKtNbQ+chOABtmQUREUg1+7yPSrSHyPAcfvyZN5NYZfdlByzNwd0hEDFahqT7fY
xZNntdGqaYu9RVrbqg+S31vROi81pocbz+zsr80QuK9VM9FlUW1y7cDgKVdmYseHqr3k3DHzWE62
MxUciumBIA8+V63WO1UYarBL8jv41NKM3aQ6hreDlU3slx3Gtz2kp1M4NcGJLPO8PBDE3FyR2gzz
wrEbczN58mDLvsQj49o7ZayIfJN29GiMwSEsJuMcY1bve15vnoVppBCxkmfmoZNRccJdnx2nsUJL
rFiyfKhq+VOmpM7zoxXND1ezmmed7goDtDenvRvrxZ0lSKgRembRbORkk4JUKaMfXhGOhy4ioSme
CxAu5I2vCgVThIV5PMPpNPYdqj9quZ3JEjfUxVSxpXmPeqTLsM2TbNElzCQiK/fpYDvNicDx+NAl
prnp8vgpBMNz54om8BU51s8srOmxN/X6+xztclPLHmWLGjQzDkzCc4rrmIxvm26OotzXSaiT5+vY
qR+BW9ipQEig4gNzerBiILYRAEjOQANT1ku14JSD3b8Y0xoT7wxv6iyVcmAUX8Jf76Dhm96xsGz1
3KALsyW4yjzUffdcqVP3oOmM2E3Y6sNZH9tYRVwAX7i+s7Ms6G/yXn4TAOb2g+o2J290CWFEu4RX
Q9f6byX1n1tPBgFgqlS7dXsz+hK2UjnRiqHnZo/FockdD/dl1NwPtaW2uxwMz5FT1Q3/X/xINyOB
IyItuSkkiXAh0Zr3meMMz1KxkydBB4eyYwvPLceWRoKgNh3pp/IfA8HD1HTG5kUjXwlJfpIU30Q6
SlxrOnSoWI7HoBnIjgCGzDWceLvsIZ2GWyNL8utBscdnrrViC4bhOTetV6+Gq7OpkJGfGzCk7vKm
Tq86PZG/D3GtcvY1kvJCQad4QJUaHYl7t4/6ZPDzGUTS9SgX+2JLkTh/yNvppYnj7smkk/8F31wP
bdJwz2Kabdtomj/CwHf8mSf9dHLyPCKxjevKzik02msJVMnQIqaB3cMcD6EWhTO80jhquhLDYZEz
bRl0ePFIhc+4JmiX5Ec4ExdG2dpHTY3SM53cCFLq5W0hhuTMaitc0lXqgChX0qtmwGVUzQEBXdG0
j/CiiLnsG/00usn4SNCMuKmzNr1uIVXhZBns0Jfcc9Ncoq+SxJQ7QZYdwlbLuFWD1IjTQlylTS4t
cuXLxqIt19rTnjZcfU3+BU6iBgMkeRBh+ArKncS1SmXdT6le2C0Xid4Wnq9whuL/evthyl4RI8rL
3C1ID83t5qZLJPls0gXFbCeorurxsSrIeLJKEWzo5dpPJsrkvRkwn0HyoC3oKFKWWwRcQB/T0dK4
WMnbsNHTS0vC/Nd6vTklZZCWNH8yu9zSQoxPzmCpj/gazIugVOyLsmbXi4JIp99K1BZYGfSWjQXz
lIAV5SfgiNcYo9ApiHUKzrZLrQozNVnJASvaJtD6ZucVcXJsR07UTV2Vftpi4RgaV7+vBk2ZATTm
i9Ia3oWLlDPirtXJ67jT92NMnrOCtaKl2HiwpGrfV6Wl76kWdqcpLfXvWKP3LXETfBYxaa9WRVPY
GfXiJjDD5sAhdPhGl3a6Iga8u4rxeG1guLQnu+ormp0VQX44+IdzI57Ga6Tw9VGK2sRvqOkbVgBA
UeTgPUiMI5LyzRldUYXGqzOWF1VgkuAXZaA+3Dg9jzNuXRPj5NAkPawMMimOJCeAAyTMFMexrr9W
ttnfKbLP9ua8trgyBzdVDy7lPsok2wYUwqEnY3aPN6+8m5US51NN93PbYK7egnaFch8Y0AiUyfTH
0lIehTWqV7Q/nW+DkTvHsA602DeCgEiYYDA1nDDcxGpNuvcq+cKPdagaT0o/sMo7RtK/alxMb2wy
Q8AT5F3om4PAp8ts/qFL8w6YLAwoNqHBEd5dkA7N905m4R12VvP3firT19Crots4DtK9TTj30aVs
SMelBS2UVq7USY8hg9u2Bb2RKnpBmxCdMGY0vCHCvDj2ql3ZROmlmH8zqpB0EmXBXpXGVXxMYK9u
YDjSUCZ7/a6My5abhcnpgu6CQRTFhBVHzs0SDP/hra43JS5/OuIvGrWLc5zEsDvoalo/6WRNd4Eh
hekLbI2PvayUW/oSUb9TJrSWG4wh1hNuEwvuRZ7eScOqv0JzGymY5e5LpFuqu0OoNIfm4jLcANBD
Q0BoFFftvDLOEGq610qc8m+HfgiQhImV7TyPWb/v0Clf5DKFGqYQw7Dz1PEFdGMRUwIbG31vxbVD
llA/c/40khM3HP/cBwRujkqwspcERErwJw2rgWbpwR0dzqI+SVzyocGiQRL12DEdy2K296Zneiza
TW72ey62+P4CWvHwEoey9m5lXI0kk0/CrqJjHWKo3mAYruxjQHbGDaMjDS+8eAz7fVJDgKOIOUpr
r8c2C06ou+WRcrf3oGFletENUR0ll73fw9rmsNr1ubgcuim8IRMIMYZEqLFpkmnsWHe8LthGjo1E
lGrkJfgBIG6R5r0UqgAFlRjohJTQqb+x80YXlaOpRzWmFwHmPjbhu6lmALqpFewbOqmFB8ItyPMU
RhVdJB7JvNsm6ej+CM43O3ae8luOTm/wNacIHuzGbbu96k7gAwta1v1OTprD2FeIvNiHnsxeRG+4
D1ndKle4hnlwV9YUYMnwVH4QshJTBUcEi8DcdcL7dDCDH+rkQpQbDSU/NAHdJox+tfvQx2lfHLo2
c77hxiABnV6lEAfNGz38sxzLGyCZeMy8REDMy+45Edrf7ZiGCls5Yaowidr0SukiasAjFVgLl5Ue
uXu7b8ovA4dtziSuAW5YhdhIZBAUJXVTAfi/yEqpEIllRRlSTIX/pKHU92cpkbsPWm0M1mFKPUs7
V7quUrYE9HjJ98LoogumcoF7UyWd48DxoJsOyWiVuHL5M91WQF3KzkGtiWRb972LQx/s5KNL6oG2
6bC46yyjyGg2euG4MFnUmra4ploKNM+isuG3cW6Jzw1MiY80k0SyUwZ+Ud+tOgsTae1yOC56VDfb
oIQUsR3UzLk10XhcjX2f+Ta+vH6XZWoCeSEFwGXpdXGpdIP7LWoGZdgFnWv4JCTZX8qJNq0d2dDv
Av2s0hPlhw4cot0Ic+KD/coh3fYVjNgyAqMlw3S4gzTP1pDT6KSpb3pfqy4hRQ35WO6XxNKed3Qx
fwws3lfE9srfYZZh5ufvlkcU4oIlD3YHWR95zp2za/S+OqR40ATM2ClRNpPbkYbDqxuEGJnkSmyV
VimIA4msvP1EPjKXYd8VsIizcrhUACxwcUwh+l5cr9NIthK0yMYBD0LGVAQMJw4bwdLpVQcvTwZ3
k+FYxWneJfYPmUyGCrg3g8Jo02oSWycTobguYcaRqoGUi14jVidSkiydzt0Uiw6Q5JDZMKn7/Fwd
Q0ibIpKA0oDdEO+Dk1LoWwla9qzPoDkeWFq8kZtal4VQBSf6w7UQdTCfF1IL7TVS6U8EI3+poRFB
QGmb8h3jzrIxaSw+QhE7pcodejOVSfjTVEHFEDjUlq9j74S3vEq/JbAEzlLUceBnQyd/ByO22BL6
rl1m9pgQuRybjNrYHK4+qZwti7S8nOu5GtV0GjYWqor3L6fWLh7nmlMf+qrkIQwAB8NlnbyEEVjn
8qIP3eSQmTSzfAFotDxgJcO6oZg1d7O/f5e5mvm2QIZ+QtdJFEfCqFH1ntsKb2uNYYXmgJQ6kkTI
St7VsjnPvW7wQ9sQ+4nsxE8G53shz1zNVClG8U/WEWUizFz8y3E5tCRKqahCRhKClaF6FDYit1LY
3o+//4f9x78E8UHFH+0yEBZymTwkx7kMCeZSYi/axqOnntU5dnHhyT8lU/+ozfR/4vj8v9DMOZur
PzZzHvCTFu3r+La9NP8v/uwu0SdCqaShn1IporMQ/bu7pP+Gsp3WikpwMG4ejl3/bi95v6EJsVHt
Ypqw5s7Lv9pLpvcb9dvZH8p0wVxi/ZPukjaPsTdDnj+ApZTxjktCJdhkWROm+yXQI4cDC30EkEIJ
0kel7pIrh1ioc5r/xk7ElrMNwkpcemrbnjUW8h3SNp39m49288effNtn+tWMWb4J7RpMMjiadLz8
7yefCPIiIcVo2LCbp9BnGiM9VPlkPXdTrz7ODWcPEP0lAoe5tE9j7tAA8P8mWsWCmgHY6NacWvMo
mL8x4jMt/qJU4/SJ72pRrZ0/F7kRc/6GPidIOwvtnbRbkM0Gn6uWHdGjiWIcmnp28GzZrOtt7gbV
J1X7v2Zr8CdtG0OwQeIIOufFDqagW5KBzuUJlnmXTxExFWV0p2gESKk0uPahPRo7JeieYkIRdqUe
GhsDFSq6Y5rkpjsC7Ouh2PZcLP4oXv+jqf7/aUeZafLxjP8fTTibwAsW4T/M4KeX//6veWb9OeUt
4zfb5BY17yZMq7dBQo7xm0X/BbsO2n6gEbOo/c+OsjLbu9l7mNco+eZMoX/PecWyfiN5yLHpwTH8
sOX+o1k/j9J/TzX+EOOYv71sQaLMKWHnRjD0su7r5I3PQfdJH+yjJ8876xs9JiVwVZgdT0a4ukGJ
v5kad/PmG/+HBeKjR89725tHU3cQJh1joC6ec6MaoNA0SjXrnj3/zTfPRhwD62m2Uaq9MV1SOBm2
AWjH3bqnL44TgaY5LTm7qa9JuErWNoybT04QH32TxVpJ9iuRYC4gqGko5NlUAE5CYO/drXvvec94
81X0ACNlAatxrvzNQXfJBH3D/Lru4Qs9gzNGTm/SJ/S7HJ1PWIgfyIHcdd9ledqfsAiZtaNm/hzp
G4TTBZGSx1XvvezT8Xkr/C1Ylluq3yCMM++7h+xMfHIE/eAXBdLw7ps7dV/34EIyZEzdcF4mnXYZ
uMonZ+2PHr6YnZZwTFSMvHuk/6yrcGuH1roJtLR9B7YdDE6iz2mM2B4qGAumAsRq3Sef/zlvxiEG
7bRFTZ/6cVVfo6KiAVcN6ifnjo++yWJyqoZLhUqrMr8Zx+wnsMLw1Ca6d1r36osJamZA80rZZj6F
s2prfJZk9dFLL2ZmwB13jBMe27cks6K7ppE9aSsnz2Jm4kazCedglIRDcmjCXt/k1HXX/ZbG4hQj
U41LXtxkvnRCwqIGvMm9i/V41eeek/vejpSoIMIy7FlpXS87eJx8CKIyP0M8fPDRf3Xw3wzDKc+n
PmynzHfCGFi+ZeO8cYRY+eqLuWnraFQnMNR+lVy0HUFBZ+s+yWLbNHWyuCdShfxYp0ESEInZFNUn
p+GPvsj837/5IuCsI9VD0uujWj/BWcx/RKVlfF/34ouJWdtu2w69gcbBBjrS2Opsg2qbzxwkH737
YmZOuUrr1LQTP2jj/dSX5nHUlD+xRx/G9X308MX8zAj+00KVDwOouNwBWAV2bQtn3R7xS9/z5rMn
mkmUTJIHuwb8k2qCnpYvq765vpidmI3qJIpF4qOAbTcWzSYjkOtm/tIpU1C0UbLInWub6i4fqu+R
RnLHuvde7JoasEiC6uvEh0xi0jxsj7mTV7t1D1/MTCEdoOUNL572RPPMQXBZkt6ue/Zidko3KnLd
4sUTHgsekv5dfrPu0fPYfDNKigGWh1vw6Aag64novzMVpf66XXPJ3oH+Bum55eF5hHvU2jXmyrde
TMuhNdsmZz/zITCSA8HiTeCltnKYLKZli6AEmUvEMKmJKW4jFSClNz6s+96LbTMLlKpIuzzxCaU2
s0NAU8P6RjxBWa07vS0LAA5AZzQ8WeLTbdi6yteoMdb9mksox+jQMQiQOPjo1M9EiE4KOcL9qs/y
i7XwZhhWVpR00pkiP8n7Z0XpLgKrqtcthEtdb6k6pC5GBklqxmB/SdThwbRC/WLdiy+mZlDU5J14
XUyOQHSJg4BLhNq363blX5X6N18F6LGWjLiAfDV2hx2O229ciKJ1w3wplQ1o1sNLtiI/FjAMXIW0
njJv1u35S75VoVDniDUeXsXfvKjysYqsOwH9KlG++SYKSU5I78yID04zpqk0on4UrVz5cy6mp2j6
EEcRY2UIf7BXpJsAwse6D64uts3MjTWow/OvmeklkGbx2AL/WnfhXMJdehnnuh7ycGdmj1uH2X2y
aoTProa3O0Rn6RxpR37KPhFb2Ar9prPJLFj38MWuCRmNDqDke6MfVukBljqmMaVfN1bUxeRMkkFJ
kGxFvj7SplH7MNlWMG4P6959sXVaUgKccXl6qfZXWdq/1pPyGShofsZ/qL0tKRwJ4d1Sj/LIJwUZ
srRpEibxqcngo4fr739RE2yzrCOMTzTukx1udqSHeR2tm0LLPpXeAKVQQUCwpMDTr27s6mnd917M
zSZ3JxGSE0wWlZJskt6Tt7J33VVPJ9P9/UcJy56cobpkB6oTAtCOGULiNe9teYvrJkk2Xl/j8/Rz
pYRmZzwPHeWPdc9eTE7HUccMOXLEqbPRdtFIlBfJCP8ICfO/CsCWt5icVU30XFm2DPDOAxc/yR2p
pPrKN1/MzajNSKyDteaX4iIeD7lctWda3mJWOnrZCTl1kS/K8aLKsstJ+uu+9eKqCbJzGrAe8sZE
nYWbdtVWaS3ZzIXZd+0v+iJ7/AnzyrmB2XDdGy9Osh5STjIDJTNmss/y/tIY40/6Tf95CWHVfz9b
shGOxmCyKdRRknyJjPahII591QpiLSkeQ96EqTPwE5aZede4l1UdrJvky/7lYBqOaGCS+eZ4H3Z+
Ea0bdO5iGmooNRoygCLktNrPkSiPaTLWFZRASLz/1BhwQyFyht0AOPYQpCNJQD0goFVDxF1Mwzwk
+0Md5kFdYmAlCj3YuZ2yanenk/X+1RFRGmDYyDAuw6L64biVdhFZk9KufPfFhMw8m5wnj8d39eRu
ACkeRKgYK99df//uVShUty45Z0KxqL9OQdkBAnc6a1g3g9zF3AxVNVWSkNSsJktuU41Gtjse1/2m
i8lZSkIcJMF/fg5kIsrGWaWTrivNWrNA4e1xcFb0OQ0hiT52dsccr8ehWrfdzCKGt08eE8OKEWex
WhUkfxRTfVCNIVl1eaU5+v7haZ4mrW3AuB2FXo17wkZGVF5JN6wcjM5imjZqPnLf4Q80BBCep1n3
ktS6+WXVL+osZimK6wqol8q6pd0DRthow7quI1zq99+lCzK9N+cVUY88Qk8DwkWIo1g3QZ3FBHWQ
/ZKmyMPJyTjiGCFJddXZG+rs+9fOXF1QB2PZSt32JnMVbW9H42d2uw82tyXGyRkn5LMF4eHSE/IC
Rya+fxoR644RzmJ22moVpoQa2Ps4acIdbq3iNPb1Z2qxD979Fyz3zfWY2J2ErUjY+1BW+QGg7XQK
BGakVePQXkxRxyEJSyO6a4+uReLvC0c/spNh3Zexl3NUIR669xp7j4+4OzbhpO0HLuPrFvSlOVkN
csVritreu12VX3lWOO1IpxAr330xQ6teq0jl4suILiVFx7Ty7YiOa93qZS9mqRdKhRSlxN7bKdQs
AzbuqTHc9Gbdr7qYpuR1DKKCFbUnpFA7Z89WNwFR17t1T19M1RJE59CPpb0HK1nc1qCXTmmGtH7d
0xfbqMpJkYDjav7uQ3dLTCK5RpEzrPwyi7kaI/oEFVDYe1y3NuFDwn3Kza5bt+FZi620QZ41pF1m
76EbEfQEjPEGdKS4XfVlrOVczYky1wVjpkz1clOoaX7Z65ay7viyFAehwCaazOHL5AkEwU1lYw9U
yYJZ+fKL3RTykqmMcJf34OpL0NiutsPlvU4kBPP//e4BEwfHe8yggQl1WytDflFJt193n1sC97D5
TLoa86tSmgx9heTfTapLd+V3X8xVSyWpscAosrfMob7Ht6L/DvvKWTebljj6ru3QVQ6swJ5HUkVQ
It50vPgzSuMHe9MvKN2bvUkRqWwAfbJ7RKlykWelskUo/pl3/6OnL+Yq7saox5Fm7ycRkCNO6M5G
gdG4bgVeaoUSkhsNtwqsfa6KaF/jXfLTzLbW3R+XciHyQ72kMdm1RZLq+1Yawm9NSEGrVoKlWgjL
OohvEs73+Wz7HCY1OxKWJ5/XPX0xVaVbVJMFvJaA9wyPWWaBAdWMct3usZQMgQKu28TJGe+W1I8c
IN3tpI/pyl91HktvRqSnN20RYYPcayQ9Xw0ClSw0LeXLui+zmKs1h4JSS9j5SqFb10mRPuvDpKyq
bYMOev/qwMK9AoeUNQ/3Ygf/Q/qWWWbrDnrmYlu1Otb2upMcUi3zBt5CfGnZvb1ytC9mqiK93rZk
a++j1h53WQU/rJract2rL7VDiVaTjgiTfN9rRXgBxEc5qlNprJOZWUvx0NhGrsBfz85kCwtfTG0C
JtTEuqm6VA9JrdM7AbJnP5K+/Aod1jyAwSzrlY9fzNVQhaw90xn2lEg1v5bWeOo1WX2yaS9sAv8q
GC9p/4XoPT1L+fQtiFUf87yLJVHtjk5AeqATWcYms9r2BADy3NNy+KJE996nHPFXrnTGYj73XBeI
+2bvha2TPJWj0/6OkThfN+WMxXzuzB47da4RXVe06VkDihTpZfUZqny+5fy15WMtHQ1ZnRlti7tj
n0gFFoVKXt02UWF2AZqrs11KHO8uE3247vD5ywr3ZunLrLTjlsXCGpmwjkxibX00q/p21dK3FB9Z
karUWAYZx3bU+0VBqo8BtnHd05cCJBzEEdYnLlvAtfMj5HOizK1q+mQYf3CQWEqQollW78SZsx+t
0eYWp7hH6Egru0HLmArgCX1Mgou9VyHrvAxVa5/3YTHer/ru+mKC48ALyE7kmCIMHRal0nvHZsau
r3v64tyMLZGRrHCAw0g+ZjslcZrXKiz1dRoqa8mPJuMK0tPI81uAayaZhUQjBiRWDuuWv6UeaZhD
IQvXBCSBQemrq7bxxYTl95Oy6wcTeEmZRocoY3sela2RSjJLWWO3nld617kRG1DaWhK+6deFKyfB
YouWlOkhTMHeMPQq2bWg/a/KXkvW3Xx/cf7eLA8oEyaXtGXqSDMASU9MUoKxpa2rlixFSvbQ24Na
ce4ClNQ/FPEAxSOfzLtVw3QpVCL7eBjNgfNFq/bynGAz/JgANFcJrOANvz94EXrSpENoUYtBzKFt
C6IqCX74n9Sd2W7cTLalX+W8AA8YZAwk0OgL5kClRkvyIPuGsGw5SAaHCAaD09Ofla5qHIvS78TJ
Rl80qgqoKvtPkjHH3muvr+jC7Lzj0VqvRJB5riSWnr2pg+WzizL6q4ujM0MavwvI/uhYCsWPHgL8
OgTQ8S4K9FPBqnl7Xsuv9l/VhLBeZgI/PkzT49BQckctTJXO+/XwdcvXIBHALStCvwak/zB4M9kI
3CLPuwusJUsRyu1zr7FiD4+1NjtkEWkfUUwfeWeO+dV89VDJouHdGu9Z5+IkQ7HP3psbceagWZ2p
S0NdRHUb7y1Qrrd1VfvXIEKIp7Nafi1doopFTZ5H8T6yKB4C0yP+JDs9nncUWWuXrI/yL+LCeC+o
KQ8aYPNE6mk4byVb65earF1c5PEYZ0IY1PssrH/kMmxfzmuZ1YYLvAYsflyAdufe/BnCqB4uCYM8
hdb7h7PIWsHERa6AtJ9jWJDAE3LLloorUF1OEhn/6fdXE7ZTeT1ZqbN925Vd4jeg8wlImc5L5K9V
THWYTeUAyuV+Jl2wLbgdIGXSp2Bx//Tuqxtw6/OSW9GCOjMwaKQQeE/GMBy253Xsarq2BYtb1NrG
+1D1iArUvncBfHn8cN6vr6arVKgHhQImQ1C86R50KfJbB1fsszZAgKNWC2WFeiUJju0+1zjWw389
vO3hCXWeZgCo4Nc/X+QZYGf5kO1N6/s70OnL73VT98/nNA2NV/trF9pZuqDx9sUI0R4fSvj6wM/v
rD0EeOTX7y6muM1Kar19HtfkEw/bozF6bn+e9+6rA/KiFWBefe3ts3qedg5xtxRm5+SsNR4GRK/f
vW68rrQxMEvSVhW44LP6IEIV/jjv3Ve76zzBafiYJNtXYRXc5MQzH/N6OQUhfH+yviHQL34O9i9o
AvvBDNNTMEl1CVem5aybOVwQXrcMFaUOlMMy1ixLsB91eVtk8IY8r2FWczWDqZWx7ZiBfuHpHZkn
AC+WPD/rWPAGWZQBz6k9BR9WOjAN2IRfpjCRO088RNeCpwCEJ8kW5u37Bk6sB5BXzGOYcR2e+far
ySqBXrCVBFiZCBUaDPZ+EuCNqfG8iBVK4V/3bAn/B2IoPgBxd76lYZR9CWlRnDej1uonxVwz2Rxr
jZs7c5XDoPZA5XTqQvgPY34tf8IxIBBzxLAMz646wO6fflZ8rE/dZo9N8DZgBJu2102jNW6Zczt6
+ygHQWKTuclPUePk9srkClihFu6qm7OmQLTaaqFBi6qaTt5+tmCItTIMUF7S2jN/fTV7ixZAvUIu
WJPDKbz06dEeCvGFs06X8AZ/3UwFxFCwepMytSOD6asfMv6pRVCn25/VNmtBVB63cz9Fvkl7R7I9
SOTjRQk7vPMm2FoU1XsBbWvR2rRVstq6GY6w8GUqll/nvfxq/lLH8oKgtDkV8dRt+5zBRTVX5Zkv
v568+ezxAgTflDocXvO2GlNTApN43ruz1x2b5bGXeSED5Wdu4CAKrzL+QodOnhXsggfG65/3oe3P
rerlhYJPL3BtDTLcXHXTmaN+LY4arGnbLILjgICxNdBVg7vutZJnjsrVjF3gSlNQP+gurOsp3NIq
qeHLABzrmb+/mrPKNWGtXGQujk4xGx2hVxtYP5w5cFZz1kAFC6t1CURNWQFYABfnexX2511LfhM8
/sz6tcqNGJeTd1EY/WUeWfNSidF+PWtUriVSXTSUYw0ny8MQ0uob0EP6p+6bU+pL+K9g+L2z6r8R
STk/mGng9CGf+1BeMUS6MpICuhey5noOcufFqKOxpX8FvLCgN2ocvSiF2d2cvYxHazFYtjblbz92
28KqLwHH1utvPCqaAd56ag7FXnAPiAnTjPAAgxX6BKdLb655cJkDeAxv2HDJYn9fFuDYPHtTCG/y
ZKF8JF/F8R+ZcIIszPLAYf5XXTZZXNQ3Ihdlc8lkpOVX1zjjCnBA7NQ9+uZoeL1Rc9+DMIqPyCR4
4+B+ZonygUL/6QElN8LSENZq8lOGHL8BPIR68DqE3XaX3cE+vpyua/hS8W5jYc7abwkF++tBD7Ao
uGlhMbl42xKiTwBc4WQN9sg4SX8S21nPrPtcwZoRvHdwl/QhjlzEEtkPNZjMg19VNb4/d4s5LDA2
hOofhpHmKdBV2NxGLYlNsRk7yvtrCCUCUwMHMEXRzxrOi+YW6S7jP9V9NQT+diB1getXO02R6OCe
mQOqB9+lSM3uMOA3jdlaE1HyvFQ+y00yRqYsNKD1UwbDN4iOA9EmeQQ9fwe8PMhFO5iYZ+1tCQof
u+8kA/8JBEnPCxhSbGDNzDsJZyoknW2jyts4AO79IsblBNbiSMa18763JIIhbgRg/H051XoMttjg
2yXN2czsjXUhElLg3CHt/rjELOjhyQyjK2kSNi1SX+Q+Yd7XOuxn28CPFse+PBlApZpahFgmNo5J
H4E45cCLKsNu3KDybQ7Dq7msBkTtfDL3QOtOjWBlCoOeCugvs8CbC4mcJsp4sSEhIgXfh9CO4ycH
I+T8k8kYPPZQFw63kwK82WBCqTwchMP8wGECy78VNqjKX70vvKXcQwm+BE0ywKMMSxPPh3K6KCd8
FUnnOrOVl5SojSd+QhqAxtiugc9jBkYBUFLRL98CvQJP3dJkKAE0kWu8J2/pHSs3Xb6Eyw8CZw3v
J/VFVW9RBtGbTV7quN6FejRTc9XM6jjBhOlzEKm6uY2nbd60Qzxd0aINSbcvfcH7ZufFeQ8HSeaA
Hm62Iirq8SVAwME99D4Ey1+NWbT/Ao5cUO1hvQ2KQz+WoK11nv3iSpz3Bo+2B/Cmui2HTbxOOjZM
+RaHBkxzv/MxGToDoOQPYtGSP01pAy3RxDWZLxtEe8Q1Cp1t8BAZoHgJXGZtdV9zXlyORPkfAC2q
6E/jNHzcoJS4DgMXbkIQAveawyGCFASbOgyLy0eqyCh/ShjY0VSKOBdLIsMpN9nNVLW9uh7hno46
F5gNZ7GSTy7HGFQ3dMnjoLhsZmCB6g1v4fH92WIxoe2uKydR5MCo8bG9rEo5D2Zbwo6yNFtazXz8
wj3fLi8gL8vukx2EjsukzxEv92H2RvvlPicZdu9thY2ENJtqFKpcEiw23mSS1o9kofcDVXUXwCBt
gLdQigJEbjMwBsBX+4ViMD2PiYR9R68hGYeLB+yI6RwFEES5sjRfi6bPonA/4exXxRvYzQDjntgm
djJOYP5pAFAGF0/4ABaGc/zQBc3Iv4az18N7Px4gxMG7jcNIf1V9F7bwQLWReZrauiV1QicAAW/h
6hxM30c5lJDVACCpi7TK2NDBU8jowoEJ6HLgJ/aj5GIasILCAi+4VgPxB5JUtDEIhXVRFhbTpgo8
S54mN87+TlDF6S/n4dJWHWwr47baC4Wcxh5UW9vdmqF0DUg9xTQse4acj3jMUcbvP6Nb3Zgl0RSx
ok6wk4zxh0kXlE17m/dw/13KyQA/0ec9wRCFxSxtEk/CehfwX6N7sAIphJryjuehB/Jjzxb/4Be0
x+4i+BDJxDNj9nNW1ZDfK1GNDj6qhgUpmkbSH1VEa4Kyv4hF8hOOBa5UCfg8tRySHHbm4yEyFFwc
yNej0Yd/MzZeLBM9hQf2CLBs5eQnxA3a/sIHqX18stVIGw+YoCJX467qJ9OP4FhM/nDvDFalG1vm
1dHEBQKSDYE3p9rKaomjOrFtS+4FnGtd0lSgpJZgW41T9QWmenxp73ETKJFPgfEhL/XVLPQidiOB
Uf4VcpoeA/whaKxLoc4mdE5gLl7D6br227l+ZtVEC5gVx/k4ZtvcdFTD5zmHe4xCJb/M70rhOizw
GdzIv5eFXzX1dhnKnoBmW4tOcyAo8RtfYOAe27taKbB309wHvjVKGzIA1bkjknjFVdA2vp3vxmhQ
QbOJ7RzI5SZcFvRVYkhfdQVinTPQnDAI9OoS0D+uRNNsjD5exQGZDD19r/vIihJupMscmN0yIibY
JH0HPmsEWBC8FjOvZThATF0fTC9ADLAFZJoQ2IOfdBxjKLomS0CUqTyQ2C/goDiGG+n5GUIHMHEb
owffAVZ4AzxgATIsclQIAPwqsgW8i71Gjiz+hPXSP5ro0yL29n7AneNpx4HvKJOmyYP5ecby2V1l
gZr9y9KIZfwIPJodbqg/tz2Mew0QowAQoIt8MD80puOSf5pGiwGyCWwvSLcJWdgXYBRPQT19xh5Q
et+cmAXokEDtZCKVMCbOX8q4arqPXeTCVqYUIPmIgLrITXzN4Fgr+ca5VsGGtiC6LS7Ayiz8eBsP
pNED/OexOD2MngC9HScbQ5sPIbRW7gAYZ8/vF+APBwl/C6DFy03Q97KBhT3aJIK8UYbieK1tYMkL
o8sWVUTw7gyrx7hpsfHDeDNn/TdvGgf5osuMWg0dcD06OMNDd1B+jZWGq0jijVUZfiFDXIZ5YroW
150ki9wCRNMEh3IohezSaIX5NuP4CFZyRefyinHQ2B+Qhg7jx2JhpurREwExiNlyUzSIlkUcv8cX
qfRlRDNWfgbVmDU/RFDoI7W0AT3NJFXcEf4Dws0WeGoYpFfFFznLrJPw6PZwUkomzTJzqG0O5GGC
fS0PPoMyVvig8A5+7qEBed9jaGVzIWTKCpx6g00Bv0QYglQD8wjKOOAXAtv3HoQtYNjrSmeHPHcW
LajmiVzjhEKjz/DYpgBwwdMcllPNAjuxp7kNldpPJhjB+qAW+Yyv9RK39h6vwgDZyVxV26sRduPB
B17TyEtiPnGSiLpx7caLVQ+URQmftuyhzejUHchUAf28UPQPjudDG3/qRT51qHC0cv6aLaJTLplz
L6z7hOR+S2+8BXPi3p9BoQqBroxBaUgKyVl1xJJUcOTFebCVMNym09CAbe+PtKBqF8ZWiher4KSl
E+2zGH+/LpFKvmA1Nqkvy5wJcTmVUcueJMF68mNp0WD3quvZcJe3dTjcTpDw5JdZ1QhU1+GyPUaX
fWO7/hfAP82wA7pMMMBbAYlqL7IhLN2T0vCreAwNrfKHYfRC1yYt6pLnzwrgXHOB5HA+kiTyuWg/
dz4SuD+XOgKgdhcC/8HhSY+M5fhRxSbA8X+Qo2aH2ZSw878AcqtCnWkB5C/8ljP4nr8QB49lbK9K
1p9HLCJoH8TvCoY2mLwMvYD5bMzVtNTV8t3XuryfcTFj18IBlpIMvfNBTHaoMQmLrog/FUVxpIHg
PtWxGxj+K/U1gBNReacQsgCiuMQ8/C6twZwE9TeLGYqwwI08wmroywCwR3w/o2x/wlVr9Hx20fgw
dTkgIx71H9sq6PNnuNdH+Hws9Wq+E2NT1Zht1dw3N2A1lC4JZD42T+GEQ2eiNRf+odRSm+vOz6cw
HVyh1EfGdF6DZqrmoL6oNIUy0MPZ7rOLB67vXDYMIDqVPViyyeA3kfcxB+40eFEQjrkUO58BbA5c
N7AsmkBgVJIysFu/H0r/uqMuiz83uqko1uyI6S0pXKQ/TQ1F9BKtvGAS2EX0qCZwHCeye88Cv9Il
Dvb45W5gxlPbIRp68eBJOwWXHXzeBSgTMDJHDcIUV7dhtagFgO4Fq8/HKZ4ntmmbzrXYbSTgKgsv
rbvyfQDYH+D5BtDDJmuOjupQc0eOPiBox+y+nAaFlXCkcP3a0wWIcxCl6kjsfG0HabeoSKbjDu4J
eXONs6cYLkUkCd/V1km5L0PM0MsaOOcMetmlxNVYFMRcZ4Pyjy6Qrj3SRwB9qKB6IYDvHvy5d9EW
UKqmuh0gM7MHly9I+PK8amsJDoOo+IVoUPtzO7EoCq9rHxmULeNeqfGyqPYSSSijxb/KOq7aH5LX
kX1yAjpV+KSHFPTkERVJ/E5qq7pdB5bLcM3HgOsDzQyIAQFxg38oaEemaxSMwhYi4WVP428KDO0J
GKplaD4qzGJ4LZQLMWkX4gp0xwdLAasWEZKLA+JLQVzfVKoJltuBo6GbauO8yQ/KA5slBbd34KDG
FZsMENoYDo0B98LkvJDIKgzIaihy25LKw4QdEZYqdWug90ES+9t5v78KBJogw7wauvwAhrG5Qq7f
v1VNq87LLa1rrwLw5QXOScuBtblNRkvMxxmVAPfnvfsqiC/Y0pkmbMeD4QW5DPKq/HI8MZ94dxj+
vh8tWoUB5Ug6Oc+FOlRtletyR/lyvLlR4NMYVFd+guqmUm57HngY9jMMtPc+zIwBIFK4asEFnt2C
WWJ7hFdx9FqmDdUxYAce7eYQG1GEasMtdXWEv2A1lVkaALAJyJDSgUiqKvfkjReLxl7KoSA5hrVF
Cs1fYIh6Ymz9UzhsFYfsBM6KspzGQyxwfdgPXdxPFxaQpF+t3xO1VXA2OZU6/od8Dl9FJSejQm+w
sz0M8EjzLquijT22DQvit9u4XRC0SdiRDL1F7AHo8A3QaLiGQwxIPIYA2uLPCXYM8EUJAy16P1WZ
7S7iOgzYNR8ysI10g1I5t6O98mIIpk1XNfYWd3+OA1nfawfUZyat1d0dpJEjChZ0luPyAEm6uTwq
6VpUHmYKl+pdUXpOsR2YEqUAoDCfR6yYWHcCsDVkMAHc0ZHxY91aZEISULLrfEqyKqt8hcssru9z
akJGELYxi7QAqmSzabfBCCugXS29yQ6XNJri4baOuHTqVo12bIrt7ynx/8IwfHgBtLl7+Q8QqO1/
QH798zsO5c3/BzDqo8T1n63Dk5eqWF7+9A0//v1/+4ZH4j8p6hhgDg5Qx79Mvv8PiDqK/zMIILOL
/d9E6WO5+L9tw0mEf+goW8E1APE/cgwrWwQ3c1iSs/+ESX0YxiwmsYih6vjf/+uVhaVd/e8//flf
rzeMQXMCQ/M4CMIIv/UbSPBniN0FBbbc0Ldp7+WHKI+2RdNdSrPs/2iOD/8Kd//5mGN66r+D4P9+
DIFpOrwl4JS+9jCbFwOMBSr5U+d5V7jS7Su4lIc/EXr6AE/dE4mg36rUN09jPp7EIoQf18APbLGc
ZMFi06gTt5KgIrQw41PhIaQrUG25wX19B769SehMEHrJP0DJ/40AqtmI4kYD1zV1D5TnCvJj++zH
8UfQCD7/vUF+a1vfvCMs4wkKCILwDXKAgPQaAHdsU9weiwSWBLATRnmF9gnflpX3mGP7MiS4YNJ7
0NCUIVilcYYspw+0jK/9YDooD9ucZqj/y03rElRHnui0NSP89+DAGCM4mnGfR+va0ZwywB25sSlg
PA7cLCyLDnDIEiaRrgwuEdJ8AjstiXB03SCodCMRbEkQd0yBZbvokOzegLMEdJH5NjbN4yKbixbc
okQAWbT7e3PG74yvGKky0Fv9UICHgj//QyzrMRB6K4HWlAGtwZeY7Q7xTplAVZGoNhYXlAMWpLpm
SJbR/9f692pO/Tm4MbXfDO4Y4ixchyg8Vdel/D4O31xlyM0iHpPivIp55J1IUq2nKTviA4LjeAaI
6i3vCKwdcHrC0qa1H1252V4UTKWk5Sf0f2u0OpAkeE6IqLOPmRP5ayUE70k9l01u0y7uXhAg0jdW
FcUOVVmALdaiSlWEU0gxV3K7FOAJmbJ7+HtP/i7v/3NiHF8B5Z4+lj+fU/zrdVfi2iuqSnldqsB1
u1ZFOe66Wg/P0TgjG1K3nXcp+3H+AlqelwxeRr5KBVmhrVx07TOl8w2vq+Jl0JXSu1i00YbV4XRY
EIy+ABi21kcGpv02ddlNZuJbbUR9wxoRp0QNh6Vc9DYHQtAvujJRgyYpcfzOac+loZT+dpTiDly7
PeBm2ae27UnSlyDIAfNxgde49vxu2M0KdWEZmeRH2vt0M0VljlsQAsE0a+8iHLh2tChxolMl9vpO
4LLm59ej8uD/LdoD4nkkGQMf0RkhQXdU3hek1tTej2Wzk3R6pjXiT4QX2yjzvR0fLuA4EuzCoUcQ
Kz4lZ1iTtn6PCAaIDQNNhnAsCa+7o60dYOG17dLKZDAfQYxy48ox32BpeBBYtZqxeOjzuEhBdJyQ
fde5S0XT0UNuQv/FFQyMl3C8GxF9SlqMbMSWa8TC6hZ5DwSONvMgb6ALRapEYkHGJ3tfpg5/qAG3
TTpD5DdZNjNSPO4CmwiObKFBzsKPfv192L03wcBQD1EagQGIoPjrz5yRaGSLrTosINYDDLvob+Ri
PyLn+fL3Bx01l+vhDXJQDOYL/gMfq9cPGsGn6rDPd6n2K3UBrYLnNtFUAQLpfKxalRv7HRzmv5YY
ByeO3u99Iw9CILD8CNCZtcDGD9uO6F53qQU788XY6CbnE0E0C6Vrf//I9XaPJqQgGYWgUmG1evOk
bLGsr/xMpwtIm8yZPNFwCJM4ZtCFfigy/fPvz3unUXkAQRCCpsAxxb9vVX8s/8QbMpgC+l3q9wXd
WZgjk2lJCiSFtpkmgAuRTV/VJz7ynebEQwWoLiQKjr35uie91pYIfoxdWstQbZFFuEbd4Qxe43TK
NPC9ZZkDOnNcFhmsNtflkgzKgNgo0yEGol/krL6HYlzSmLnNEMObho3TYXT9L+PbZmNr9ePvrfvu
h4b0CNIUgQjWQ5abCE5SMcYNJL9gjTJQwfs9Amwn2vOdQcMBswReB6WtGKbHbfaPToxhsNFnWdOl
7RIM+2BpPgMssG1nXSW8Ih81aU6VJa4JesfFjQcCrkScs0jwtb8EIaZbps4zadDH7AuX1SZA2Cgv
Yqy+c/Uwz8ccbYgADx9lgBqcrvwKRPhu7Hm7R531Am2H5ifKld7vbKRsfc4C8fb0ylEaGzUyR2dn
/r4XqEEx0fxdxz+6qakSsUzeDgjeDzAoRJQDuZ0Tp753uyFGAhiAV+TLjiijP7tBZGHJujE2KRvL
hz4eU0ikrwPe3CL59IyM2f/MBgJHGvRBiLpMnDiwJoGg9Pp5M/ckJArMpMjaXSIq8cWUw+bvA/i9
TwqxKmD88jgg6wOa5KUDSWI0qexyuqc99DMBVNkoPJ+fpC+vTvrovbmB/P6o/37i2jtKxjncOZoZ
T2x1tiszb7jTHar/6mb4bpkOpl0nmhIZqIhtIWm6YDjKwa336wAITcX1RVyyKUXp0fehDm6k8Wr8
/RDCCFGc2I7em9uUgEnHgHbGJXB1cJ6R2fObwZkUJnefRTXdjKG5ZWV+Imp26jGrQaWcyzl3g0m5
Nf4WBiMbWU1qmyGEfGIVOR4PV/srKF3//UGr4dRWXVwsEz6oWJYfRTjs6sG7qxz/3NfTiWH17kz9
vc8BNQwS4O8//2PFGoUPMGplTVqiPCFp6LVyMU86RW5txG78qDp4qgLYl4JuyeTD3wf1+tZxHGIc
+yv8nigL8e/X82acimL0NYZYHTQ+oLDR8GzBYXj6v3vKalFuQfaGCAqi2TkaNogV7GZZnbh0vLN5
RwBlsiMeEDZN/mpsTHEGYLsJddq56WZox6/xtDwQW34QeQbZWY0QfSxPnVDe7buIxmg5PJUB6/a6
+RoOvOuihU6zZSKp10xyt8wPDY61h0lg8cuKcuNzSy7KpgoPGaEf/96wK++Ff6172M/x3QSBQwzY
1y8A0lc2BVON/tPkW2ugS8iBO+dq3BBZf0IM8yvVxa8+qJpdj+BoUrf19u+vEL8zK3FXjmnIOV4D
NMLXr9AWGF5KNzptWZelS1e9FAt5GBqUBnTME3DqnOcNE9W9Gbvwsq7VmPYDFOUFFbsJ99Qtginq
3s5ZnhLTXEqkqjetHar9FEfbUPNpayaFkDadN12T603XLvBzGyRcLbxHlPvaKyLHz7PXDQA/s6tp
ilXa97bdGlKqVITZUV42+Nt+9A6VaZYnVxS400lQhhoPcjbYnT9wb5mPxvIQtwXIOwutjpxq9ThC
FbLlLf2gO3Eo8za/zGM2bmGsSDb5WN80qCy/pr6qkmApdq6XH6ehGjYoDLqcOuRvoiJMFQR/G6SE
yk298CGpwTLfUsQWKNLOdge0SrUfPPPIiznYz57kh2wJ75ADBEG9LZodBCvNV7LEQeK32ZWpuzG1
iwdhShRdg11d7Wff4xuuXYYMFoyKqe3JpeqQnUag4lfNxDOysbdhMx/go11tpY3HhLQdu3KEeIdW
njKte2ebjHwcMokIQDXFf309HLKyCWEpOeu0H5tys4zIAOYyv0f1/QcZQ5QZnAJ3vPdAXLiiGNxN
2G2vr/oiEvB9z41OGxfPG11FcuNyf5cRdRktAzSb/SkV9JuQFlbNCLhk6FPBS4EqbDXraAebVWV5
i0OmCbaGzWqHwFf52DYCsoim+O4M/pAPKLnWMbuv6/pFw/gar4bsb6Bpkum8OpC4DLbIy8x3rG+a
Z+oF4d4RDjh2VBXjiR3tvZUC3FQsE1ilCKbqaoGcoxq2U7HUqdX1dST0pZu8/nKp87so1NCYRMJL
snIpt8jH/xq86JHC9/XEWvHOUhExgC9BuvWxYq2L6elo4MjsRIvdBrn3qkcuFK46+SKiE197HGSr
/RtSv+N6CK4xIg6rNSm0Wruxndo0UPU3XsLHi7ETJ+x1sPA4BrDg4bIBpS642av2RLQCKNxuaFM1
QqIydnaTN83nqs0vEJcpkuPph8vwXlh2ynP2va2OH7ccn8GQKHyz6Sio5MPJb9PSFpcqYi9QuHxk
tv4w580HBhXWpimHE+U07xyIIpzuIoBBA4GY0XES/nFIURHs0JFhw9ceCwDmbHk0rN6JQsV7mp2q
DH+vaZFIQDz4mO14E91wc5W18F7XacX4B690aoOk4wZOQ1datFfQrkN0wh/L3D+RUX6vYZG94BEo
6GCp0tWoYSPPW48SnQ4kQaR3p4MMXKe2cFttyI7NQYVjmfry9/3z9410NVYRpGTgnEcBQmTrom8I
xWrLsLGlwxKrA/XsNSG4rlHLnkNYT0D/M3PoMOvngvcXCC9tG6WuyMyHjWcXNIuIzQ5B1Xovx3nZ
yC5kEK+KkO1gjbSVXfmDQqGejJ7dSW+0m4aHbENs9ygUe4Zm6Ss0i+EWQqhPoXIscSS+XYTyUgu1
chK1+Xd4EYNrX1qJWGN0hTjNkDiAlrdlrHLoF0yUCNEF+1rF3nYozOPfmyc4zqM3zYNQGi6RcRgI
uppnrKJcx1PWppOtcZgSHk2Q4aR7bf2kW1p2SWcn9jrzL+fj6SD3AvMNJth7Zavl0c/ptne53Ym2
PjAQ7ndEtBSNYeimLOhXHkHuWMoi3rc8PxUpe2djinHzhQgEYQggfY+r4R9zppdHtWmnsUvwSW4m
vA/kIwvZjnaS15FGrzoTRScm6juXRoI8C3JCMefwLloDOapqYkEHi760G2m/BwtJbIIKEQiNfRkh
EO3vC1ALNzHzMggrIXelBDeLsmz8JM7CTyxiz9PYf3ZDNiajv9yXmtPLyVRm5yMBvv97776zKx0P
CWHIET8JgTNfTTlte2mEo03qxwjU9uXHsMn6pGjbbmN8OR3/b7wm9AakgngydKa+GIORnNiX3i44
UDbjrBKj0ZCqWq+oU2k0gaqkSb1ZXUH2eOv7+UbZedfnZNvM8fVY4Agb2VPXzLf3BxSIR76gCHKi
SBpj5fUQYd1UsGwo2rRyuoC2K041ymmTuY82vnzusvwRozSZmLup+hPf/GYvXj16dXUxFgoNaJew
Rfbzhcqmw9wif6CHEz184jHrkHg0BDDoNQqTIB5umgqytN4CV3Qq3vRmwz9+DaEIwx27MFzLdqRf
cxeWaEhwKrpDxk17VaEwaHdiuB6H46vF6PiYIPKPKfMAJ8DVwS9YIgd7zbJFnkLtg54+5pze8iJ/
HuL4g5OQ+CGpdWU6cxG46KyHY8MPhCA4d6799nQ19LgMSDxce5eNC+9dVkJA30NDqr+b3hwkROyb
qPvYzO3hxIcfIzhvPvyPZ68+vPS8IkcZU5vKwu2hL911/JipxaVv5ttmGD4aWj5NUCBOVl/H5BRC
+M1Semx3SgTyloiwIuvxep7IRkzLqOImHaLnfA4SEHmvRnOHCqALQePk7x97/JY33/rHw1YxkcWT
Hi7QoknrptsMUZDwwW1HBuQt+5/pmHB9X33XcVj/sUVkPpKHuBo2qYXmpx3rjcTqR4aHAEH5cz6K
kRjbAqGI+bx+UkidNpxggrhe0J3mANUiVTThKrvMtwEMOs9pxGN8AjMyiMU6JFgjI8mQ025S6GDd
vgggxe6GSu+zrg62bgqrEyP03U7743mrESJGBV+eGp1WSP1BkPHGduZgon7jB/3FGU2JdYaGDCfi
/yLtPJYsN5I1/Spjd482aLG4swBwZIrKLMmqDawUobXG08+HbE4zDw7mYJLXjGRbs4rlGYEQHu6/
uOqjRCPV4STysoMUggQoTPXRqnOnStKe9HCrmX6Vk84rhL4CxWuRR+7yu9UCJvQWmLpDOOK+quvp
Lqz0x9ZCMricTlECHkFQPt0e4PWtTOeeeqD+0kKXMe+7XCxqJQoihCc+Xhs6OUQWt/aCH02Zwigp
ToKa3pdBGdp+Mu6yxviQdNXG42rl1rj4ARb7olUh2YgD+70Mgd2AuFXpUCRm//72QFduDZYMLzhK
1jQPlrJ3SalPMIOZ3FqSgjO5OUwmJNo3liaAq+sThSIhSHeRTFB6gWG93uZ1g0l0HpPDArz8Foai
916N0OIkI3CSOtvVeH08j8XQ70Zl/DkW2BR0lPzcWEZJsBzED7FQ/okleQkEU+4OYHyrEwL4QC7L
4gO8WX1vTNVxlOu7MlceokF+HrMit6NQH06dFHR7lLIFO+hKzPy6QXTI8QVIbMUn6lP1PYQC69BQ
7t77VabeIQnezJCXFghEE+c4jHmsc5rlVmUXShwe6i41/8w70T9CpdXu8y48dpnw1LVKehcTyc31
yXKsXjyj8mVCWVLuPJDV+6622qcpE3Z9Z2F9XEnyATJmtovTCc50rD6WnvqHT33LHej5lhqcECNt
uoOpCp+UKEnu+UjftEQfPjS8jp3c8idbVorpOPjQpGaKw1Ev8syGFFWe+k5AuUxocgf34rt2Go45
7mC2lQo8V5K2fAY2bh5Ac3vvVJhmB1ByiR3rYCxUjVeTDtfRD7TQDj3xa4H1do/4gK1k8jvDk06w
LMaC3p6s7asaHhZwHuNrQFwn1OT6Hh+khoKfMD6Msdi7QTx5zwFcPicLo+pMs9x0SnbYOahE3dbm
4mEfxPFvAbPisy6PxaNYkXq2jWePrV/trKjRdsA4o3sT2owjpuoJjoAGuLcRTz2ix5Kg0PtJkx7U
uNTtMkX6oIz+d5RsZt+8D6Gk9OdQMlJoQFXuQEP+malJAbq9+sEze2LYlqtQP0eta2oOyuz5Csnl
2IMt2CGumHIHxgBbwQMcLQmGrBxJx64wHUtWLAh4o7Lzo0hzaRsrR0HP3lF559v1XhccQli79gRf
94+xQJ3JHvyovQOcgwKkqXj7JGqmzInkvN+lVXDuq7D+JAFysYH6IR5mIBospb7uGpOan9W2Ho4p
tUTficpqF/n5HzmqWntfiWKnN/v+2Ww6j9eh0p6E2nso9FH80gu+dvZlP36qINQKeNtFhl3jbyeM
qnevm4Lqeqraf9OyKjpkTHy9E0EBKPsu08Xy2A2S8KCrZYxaRl9BNpG80bagKcmGH+w7Zaqf4bfL
B2OCUcZ7LHbgIA0O9dzM1qaiuEtpVZwEcdihhBwdojzX+c/zz4bYHKW0z79rrZ6fvEh7zzs6/kxv
U5RhMYvWqcQb/HugFOkO2U+YwNlY97+1APdj2J4YOp4tuexNF9uEyImj9mM4SkhLyBSB08BpvGFX
CL2TKlazT4JGPw8yvsPBIN2VIrTKtoBk2hvG9A5QYOXggrpvK77JpLSzD3LdVq7U8mKz89FLnGyy
ukOCPTJHitD397Lvf2/EXt95DffrbH6tADr2p3dNAbzs4Jsj8EKePY9GCsW2UCqk2gpprH1HSdFr
Qp6bsqfpV5NTyDUQJd8v5YNgtICWC9yoIa1GefFOELLuwUit7lxL7Jm9BFF1l+pC/SEcBemkJrmK
Alyqhj+H3HtnBGbtwOLSdzkEQaeDzfgsIPWu2FC8Awc5g+zei/pT19ePSuD3jldmvzQoEZpTBKG/
m7lWlSOEkLtnZLR+kmrNn2VYqv5Ry7T3sZI6dcML2qIKcxfHQW+nhae6MIwdMVbfxW30BFTxuccE
JvCKL0UV/arGQsBQQbjTkuTR9MWjEfZnSLGjbYR67hpGEDhtJX0RpomyjAgEozUjKslJch6B2RwQ
Sb8z9QRO4EglJqyyHZz5xOX98Qd4hNrVM73Zx6L0BQJrsytJfJzRV57MmmfIAFHrMATNEzW7X6nJ
uhjqsXe73j9JAe7wXDmf5YR/bTXGnwRqnQQoG1Lnd14R4u6nur3ypWsmkJhV+6XW0y/w0+ZsWOCR
LBbve6v5EJvKg5BCPIyb/N4MIb4KKqCn8n3XqD8QmAjtXu933jTSlA6PPjMjjdaz0Hhssc9WW9U2
3I1dkmd702wfMt2HupNBtLKgTUnUolzYYAgbVcG9l2mO16S/o44JtD4HuQU51fqUZeGeWvcJ37Y/
vcg/IITxgCnuXaC1u8Fsf0OZ/QTL04WG1p+nWJ6LpWTxOqCxSPlgSMIdtz+mFO1hDLUDxfNHxf8q
DQ3SD17wpSv0ByWGXcjCLJ0+zp5kZTpaiMK4g59k7wWJnR5P6WelG+1+NA+Slr+jV+zoHaa82SD8
RDSv43T1H1UpddVQ+iqo9bMaD/mJc8ZuTfMbe+pb3I2OYcS7ZpCyHxYFPz9I70TM5Q++9V73kL3G
+vh7CoO+SfWH6oVk2LEc+0o4jol6bjxNOir8i0Hx8qfIDxIX3u7gGmIFda3bhSQkbmY1kauOeuOo
5nRQy/p9nA2/+xFof0nvvjknNczy4RDoXVj/MQaIGz9rqYrc7bOXGwNu2pDs9n4YT2cqmH/eTsPW
yiAzsF0BRW6YJH4L/IA3eND0RiplkVzdG10AHhCcn/lV7t+NsvgONO5nX+2PrRluvalXHpb03Cn3
QooE8Lt8ppTZgPx6xrOorivHCsxj0ghOLHxAvOjR8vQnpRBOnkhHtS5Z5/pvKdTOY2U8N5JxN9Xf
xURwmy1EwHXyC0pXZ7lRFJqfF4unWq/mgu+jQnHwvc7p5daeUqRaQIPenvXrpFRi0DrAdhW0Lo+L
yyQ/jmXP8rokY+E3jhfKtiDMUndQOREb6AI3x6L5dsTrgYmgZ9DJkCl10U2Yf/3Va1cVA8i7c/Wk
1/STKXUOyfbDBKnmdpiVp+CMB8ImmQ6koiwroAFc+YzWaX7AFfHsW9oB51nQkNVeLLfsbNdW7vww
I/mR5jbQUg5MzXV8sg1iGWlOAuDt9fG7nH2Gez05SlbTFFJUd6S0XJhbfc+5QLcoU7wOvQRi4t7u
ZWHDbI7JeIfCxaGzkvnqL05oPWNJyoWImsC5U82N98z6/P5nzMs9UwuDUKV9kB8Uz/ooVfVey4p9
W2aPaLRsKPWtrRhKCCY7lOcToPzLFTNMWjwUGWUnIeOpqUjPPFGc3Gw3zJtWTgENcQtZAxXJd1y2
YHw5l/SJ9v6h7Vtbt77ISU/LSTmiKbKLBWMDqrK2aEx4EDONh6ozj8/LUYl6a6Aq1LAPxvqsi905
zTvhWJnxj6kqKCEyvfDblU9+GZx1YwsHujKnBKVzbaqwf4ylul8cJIiXpDmfb0rpCDTY60QGGjxV
K6kbO/H6iBHhHs31OhlIAByXy4GOUHShHZb5IYBKe1do6bRPU7mj+dCHxxjFJHeqp2GH07e+0TZa
edm/iiyJy74CWgKSaDBIozZPc/fQM9XDm4+ZuQbEZ7Q4p6FmXQ7On/QymUL2nzY2d5l+NJVHheeE
pisbgVZWJ+AikDUSiFbVWErTpbpVBdhI5Aczrv6Qy/cowf7KBXNX1v6dUesbu3ttecBDoYoOS4Se
5OIuhso4VDHZ9YGWmTNbS1boffnD1uytfKD5fSiDIVdVWq6Lu6AKE4REArYckIRv1QxN1NQNuOBq
CFoCFOthZ1HRuvxAQ5JNuA4QYgjHBz1NoXg35sfbi2ArxnxWvrrSIFdmemBxQEWp5tB2tJt4q+mw
8kEsGQQ8xUb+V31pkL4KAeqlLyhnZIfGEj+befirK1QEucZ/cDvz5898QB6qYIYX04UAYjqIOnFQ
gPjcpdGPTskCG9T47vaUrY/n7ziLKTNUvyu1gtoeUB3BnuLO7U3zY0lF/3ac9U/zd5x5W72aN6FH
T80oGQ8Uv2fRUJ6FNNhqFazG0KAXzXwqdNEWc9aOeqVb3nw/Gd6u9eRjWW2lGOsh6ExSQDQ4bBa1
2MIczQFYAgXgRjhHTXbfderx9kytXOiUGgF1QCPUGMvisBQ7C3SiRbk3n5I/Va99GNPgR1mn95O1
1c5fHY1Bf460VpGu+nRS5UE/LrUMXzqzRjqYIXVvxqoAiQEdo+go3/GgmEm0rz+8ZOWx1cV6dgCH
9GgJiGagU7FXke8TI3OjUL02njn5g1KHNKKxdCbW+yZBOV4kViM+T/V739s6Yda2iwo9BBPZGd16
leZJVa77WsfHGdP7+VWZezElxnAD+7IWBgiKBf4FCRNl2YhPAJCYvsclo6DypOYDJUpePUq10YZ6
MWtaZK1clwbZOd0T6UrvfaIWbnoJC4Ai9Du0UWw52MuSgQRK6RqFthciEGiW4SItddIo50i+fOjr
r7Ee2pku2WGZOfHPdJpziMlWkR9CnOMQ54VLPnzOevVDlk87wYiPldLakvLYadrGBblyHV+MYHHv
10ENEsBSskPSKFSXfzSqfIjE/EFWq50qV2+//Nn5QNkgVPJ9lm8m32rF0ChYzMjWuOL0ThjRY0Az
csj/DK2tJuHaIngdbHE0pwP0PTMkmBhQq0X9LGgN1Nq+3D5uVidQU2hEkhiColxkGFkQN7U5MIGD
NtpsGGcQg4MP7r0gt9e3zE3Xx/R3tEVjsOuoORc50aYcqVNlPGjC50DeSDfXg4DjkGd0HDTnyyPH
64wySQtgLKYw7oTsWbRyN662VNHXzmky9v9EmSf21Y2WdJNYG7pMWy7ybNG6m5rBNin1SltWSlvD
WSzxAnB0NyoE6nD2NNOfifxVK7fM4laXAUglxYQjRPF/8TjgrjO7tJXmPKA+CP2fil4ecsFwKXc5
Alpqtxfd6tz9HW3JpQG7ELY1HpEstHo3+JY7wQdF4ZEl/mbwKfePNd+mwEToKy4Xg16KhSLqI4tB
lB2oCHvkijaO0dUP9CrEYiWgbWSKHUp6B7TpXKrKZt66gfKP1huEXZJPLjcw/pfrjX5O6NHdyHin
PuDxB3Mj3xUir+ItEuTqx+GCw96Zf1wBPn11xFva4BZtaLnhC7cbpcZpEHRV049vXQbU1iRevzMu
T74qQWVyYYlRSKqTYemlKOWprumQlO27iIf37VDz7FzedISCLgZgSHlh6l7OXicXAf6eHKaeYOzN
cvwM/OEQSMEj1t+HVLmnXZtFW06i1wuDoNTYdFEEqAtW5jJoPFmJnmYT2UI87UTjC3qfjyn6hreH
dr11iaJxH+kUKme65WUUS0ITy0j5Xj0a4FBKaACmu1j8EnYyVQV945utjolnMxVRGMFXyPUSUpnm
l+ynBskxRBQPiUC/sB92twe1EkaikseGpXYIKHExKLqQSRxEY0qiJTtk3PeM3C7bbOMgmv+YxbKQ
4Iiz2qENgSKbf4xXh7g4gfANYzM9+LUY665ZiM1HM0Kia2P5rQ0HPplhGYDtddD2l3H8rEvCxkLH
Is3VD+qs79ZrT5Bb3pwAz/B6BS4E73jwKYszQppi5M8MJQVBGlcOim3BLCO9cb2urDdNMhGwAdYK
HnwJk2zMqCuGZkoPsjXuNDlHdM26Rxl0J6PBgvDsj9srYSvcYkw8rXuPvm16KPtxT0vinSnL9twF
QALcxQDw6z8Ih+II+j0UqwGJXH6pLMhFuUOU6VAWKJCa1sHTEObOsM8NcdSlN3g73Mq5BOSFE1CH
GcF7f7EwRqsO+kpM00M/Idcq+d+1qdwB73MM1L/G8diOxlHwtxL/6yNeuoi6SMNavYinMc9S9L9R
3g0nUG7DbqzDQ5zq/97Ib1KSOvzOH7+nv+ulKBRyLD/zYqxCP2j+90P4k6+V/9nc/F0f85S/lr9l
/mn+8yehlfTXT+d+b75f/B8AUGEzPre/q/H977pNmv8rqzT/zv/fX/xfv1/+lI9j8fu//+tn3mbN
/Kf5iF69VouaPYRvqEtV36cwWf7+v9SlZPNfJlU49q/M+qMGwKLpf9fNf/+XYCj/siCZsGIoo9Hg
mH/pL3kp7V+yTj5KkRDsNsyi2Z3gL3kpQVH+ZVBSp/L6lzCV8T8QmKLyybonvopwAIfA0vFJQVg6
kn2k6EokIRRnChq0L9o2AxbiT3S/969m5unfp/FrLZ7F2TkXWmlvzL2AWehCWrr2FlRz2rhRB9rQ
9aj9GpJYmqDmeqGA/oRqVdPP2/EWd8IcjxSY4g4VGHgCS5cHMcziakzQQigR430PeUP/CPAtOrwl
iq5wpVlkWDxQZFJHUOeX50yHiLIvYmZtm7LQuWNTdI6Bevq/d9//U8focqP/FYWrGgqkCUZ6eVbn
Xl0glZ7WNjKh1s5rEcOrsiH55g9T6cIXEt50Ac3xuNu4sinCwMRiJV6OKpHQBLUGE2HSylL3odkP
+wDXgY3b9PIL/TuKonGVoj2q815ZvIgkWs9RJXqVjTWu/EUMy/TUFMPk3v5C13OncQ1oUCF46pMJ
z0f3q9ygKhMxaAyAdkOsBoYTWEjWQuPUEN7NrTGvbansg4+3Y16u9ZeR0QcmmRNNNiwSJJcxrUwp
ixS3cTsvM/ksCqXmIoYcPQDe1TeGtxKKI4YNNWc+12wHuUD4PG1jQiVdYVN1nPZI2xdOHaXJRuNw
ZSbpbFMtn18VBkfQ5ag0KiZAVdLKBs4Qndow0o8658Q9at3Wu77KjY0S6sr6eB1v+bwcm3zKucIr
1ro0FccUeVZhF3XgXt78tWDgoabGZUqWvzRj9FJzGsNcA6uXlEHnRBA2R7cJ2+mbQll9I9jaJKIr
SJ+SCwCl/fnXXy1Hq6x0s45QrPVHOXbbrpIfEWDwHE01YUsPprqRmaytDxTDKGGwz2DVLrZyhySx
2YRyCdmnVW0NeuwubGTD9kNIxG+fR8TW6N7pMum4vEiCJEHTYvRwS3usxMSFH68/1tGEWUPqVxsb
7DKbfNlgpFp/h1pssG4yiqqWGBX8s3dBgGo5cMryMxwP9b5X4/IzQvJ/3B7d2mp8HfJqIkNU4GPk
1lEVTx3kX7V9CNNqYzuvRqE4QFFylnpbrsXaKoJqwprHLqhEPlGDjRzBzJSN3vxqFBY7m1lXaVcv
smNP89QysIzSzus0tJUh1/dhl+sbd+PaUtdNyt4kxbyZrEWUCv+sKix1tBEr2EWOaSXxmZe092eK
udtHi/Nqi0WwttiZOo5Da+YrLQvukRAg9KdTs2lIzA5J137VVPWHXCLs9vbFYKArSNmDogcMqctd
zNMQvCPSOHZAIQJZ2NrEVEXaKjwsOAPzMocuQCN8rrTOF8nixA0EE5cSYLR2qVQK3iik+doURLui
KPxD1ueonOvawfPi+KBoaDHYZZcBbRKxmn/reGdtQyoTsgb04Oodj/+U2CGMXuH10yT6c1arAWpM
SpvWG8fji97o30/5fw9ZmYFaSN7QzFimHlgpm4E05JWNUn18FhMEp8qyUD7mXfXg68JwBh2OuU2c
S7ZCfGcY48DhGzRSY51wRy03UqHrk8bicmVHohQIiEVZbHswiJgSdFjeFCL2GnbvW6lOz7v3FbcX
fbmww6rT39ctIjYbx+n1JiWybM5wFki6V+nRKCsDpVxuikFBKrHKQWSDJc42vuzq+F5FWSyxsSus
yZ+9dvpA6tzWT2QUiz3hkGK2NVpf86gv33zEMS4+MBOnU8+1Fme3iW6/QkZZ2spoAg+2BtXp1GYL
kXN9+BCFZghEHxQLxBfzt1f3bJbLXlwbII9j39Lf5yaFDSUGLi62SfSjCau36ejO63aWRgMSQZGQ
fbI8Ebw456WocSPpUa8Wbleawh0yYb5jmiBo5W60GiCuZIEbq2Tt+72Ou8gn9NYfyjJXcQGBWXcX
9Xl+QuhxeojwaLjDi00FSh1JG8ff2uTO2SYQRxJ4uo6Xx99QmGmZVBmTG0raH43QDu1Otjp8dzNL
LGzsYJsvtw+g+U+8PBYoqkgoFvIE4lpc5oKt4veZViM82Xl15uplWblKGnU28kBvTztJpclg4OxT
n0c/6nJwsTphvqurhT32bbIT46ndD4329mQa4U6JhIREENGJpcIK1IM8VyGm2IJR9AclVlM7joxn
sYyxJ6rE/e3pWzlLLqLNq+jVbkAjT68HndNKDBNPcpTQiHXYStU0bqwM8/o7ofJggCqUyd0BcF4G
Yh+HSRBMBb4xYn0OTIHSb5aK5zzVzF2BSdXHoReE2E7HHrj/7UGubAWLYjYIBUPnQb4ENhoxxJu4
4fbHjdH6kJSa/I6Se+sUslae8go0ol3AGdoY8crKRA+FhzIZNpAVeXFB8CbRG0XCckmTvBZmBiaH
eLhQsaWZ9PazmubXS3aNDAHX4+XkmgXK+Sp+JjSr8+5OxwPyhH2gdg7hwR8bz4DSn0A02ZjWlU9K
iYO6A4kIWP4l9KMKSnlqGqIqrY5pUxKGpgtyrj5ruYKAvprjFWVauA+G3ZYW2NWynS9dcC20sECR
osd+OWDNw0SupPVn+5FZ2LKYKTOuYQvbcvUFicL1ClADujuZ6jJP9QbsFSfW7BTC7LDrNsLKI6yT
o1IYb+tUcE3MsUhNeQHS9rdeYKyvNmKMtVCoFU1hQ7weClohwvStE+Tkbc3Mv+KoiGQANrRoyS0O
sXCKCrMX24JVGY9uXYzqnZi06akc2i2ZgLXpQxIDvQV9vmiXcO2m97I8T1NCldg+UfbAK3cav1KB
HzeSw7XlQC7EFphRO7BLL5dDmZoBoncFHo2qGO4qgVw36PGHvH2MrESZrxmuRiYPjNDiGYvrEzJE
yJlhA4okuqjTfSnz1NzYy2tRWNqsAWLA5l5EYRdJpo8mj90jIeVQExZ+dK2VvflNTg+ECiUUAa4Y
7pnF6WTIaYmDSFwA62m9fQNKBM2fbnbEsd4EDXxZcReR5gG/WtlZPpbQkqICA68O0l2m7DL8Njfu
savEg+FQmpzPPs5c6siXQSRMBvF3hDQn6bl4X2KX+CFVMImyfJyIIPsPw+H2YniR8LpIPOaICHCC
flOBiy6fYFOZREk/0/RU32ICSylwhyzDVgm/2sQONC84wnfxd7CdLMiO6HxBHzwjPlTsA6WP39/+
cdZWDR8SLi5S0dIVzMfH8ao1PVaNYXWTKxRCtKM88PvtQYxZhAuZASqn6mLN6GU/hXWhYV0XVnLo
YHyCWnMtWoW+sQfWviZab9RxZIuzY4mO9dQ4E5WRxZlF2eBEgaLbYi/sJa07Zo0wbkRbmztzBnyb
sxkAW/xy7bRDrQ+4Ehe20WjeHQyx8lRwgrpvnzzMIXkMACLmPFycUXgdVBCFOQ2jOq3u4UmmuwGH
xI1S7MpYmLa5NcyTYwYYX44Fbyb81cJgzlGN4DHpLdWBRRW8tUxE91Sk+sCxwbvGVObv92pLo/Qn
4DnK2o9DJX1IcXB0Cy/b1GCZN+1ii838JV4S9FF4tc2DfRUmxfNTE1PsmaPWC++FEVNYqUzOea9B
pRC7R7PX3hfYWu7KwPDuqHWfdasoNu6Wq+SRsUqaNEtKUWlB/vPyh5hKEf0HPyEJ0DtZgjgY1NmT
Omhid6+1PcaaQ48D4KnqwHtvLMyVbcBLgIYf8FrszZZpnZAHqHqkVm6PaaTETgDOye2L8F5RfdVp
a49/vnmNcvGg/4VIFO2x5Y3dysaQTiKniBoEEEprpdobKYJlt6Nc5wUSn5TqGCsImP3yKUC92R8q
g8+qQwZ2EhMHhTGbDCzZNr0QrmeQUDP2mXc3qKrlY4qzUhexi8UrMdZCwR3zBAU1cQqkT1ataL9Q
FcUN9vbo5gTqctHSmwU3QZWR4+sKcxvEpTb4JQ5eRZZi4GWV2uey7acfZWskriRl8g9KIMNdESj5
EY/kegNafL1ckSvi9TILdM/kgsVFmGYoeXU97pBiAsc50Y1fSWXAuKc4VVoZhufqVkZ5feTMEXmw
0kmjwrpUuq97FBhlqcztDHP5g1K22D7oXbaRfM3H42JakbMHRwFubb57FsenHDWg6fMmx0hbgMxu
ZmH4RzmNqepWUMOfyribQjs2A+pFmJHUW3fEypqFFEQqS/5H5WjZpK7QHY4zAx9qIfHKvebHY+NY
nhR8zOtKiTa24XV5l5YTAAG0z0GHc/otBqvgGKf2jcjG1+snzsX4o4S5t9upVSK5ah1oH6DI80we
vB5Enex5nmELdV1+Cio1K976zJt/GH4GBo61FciEywNQTnBNnMqew75EDYLaefOj18nlM3GwsK31
4ofa/CyVfvDmq4y4tNCpmgEKgPdxGVdMrUQrC1ayNsKQcrCxVDBQ6KRwC6Oz9m15dAF0APUGTH7+
9dfXTJZFHvCG3Pbr1vvUjZFigIm0vDucKVpjI29cCwbGnMc6BZ6ZhH0ZDPy6HCCmntsTVfVzIeXt
Y58ZiDnqef/x9km0cvgBjibMzJeg0adchpI8VQPqybiMyPB+RY00fjIbozvEWZIcaWYGX27HWxka
9XmgLcgWyuYVDTBRhTBtx5xzPTcQywhoXlaVTzed/2Zjh6yEMmk3cyUyNCrFi7UR6mnh19BxbQtP
WWSYhxZFZm3KlJOEBXjm3h7YyplqklOBx59hxhQbLycygnaW+K2AIEmKKqaHVyXGziVNP4iOtfyr
GatOPJTcNRsvp7W4lBoJCVASIMlirbRNLyXQaojb42tuD22oPsojTcYqC4NPfa6iBNEFwkZytza3
2IfNXEEeubAhLkfbGZ2aNoLPUddQIfAydnkRlzmyCbW+cbSsrFBQs4AGJOrF0G0WEzspPf6fPWRu
r54mJ2kn+TBiV39sKy9yUdsRNuCga0PjST23TqgV81i8HFrZG36J1i3qb7Wqn2Rhkt3U1/L3kxkm
Gyt0XoGL+wqyMYR45pCBLYsFql7KjT96OCb7YfKoVpSOIlUL9rdX5moU7l3IcHQC8TO4HJCYFiD6
NE6TMkIztPSwGguEYEsieHXacC0gBUW6AT+Zyyh1QNtNRzECS2VtVjgV9WQ8qhE9NXeESV5uHJFr
q4Lq1PyOIalAleEynChOetWGnFtC03xAFuUZU9ve1smnbKNEHeT2FK5FmxHIwKcoEfOuu4xWZHWk
IzyR2dVY+ucsrJR9HfvGSRyG4g5F9XZjdCufjBOZKjTkL2Jqi/cEGidFP8w28H1XFPRkA/CoLv7y
3lYWsfLVCDEXxajPonU8/yCvrrWhUKWggUWAPE1npG4KbsA14txEZyv0qg9vnkUmkbYkXXY0PpbB
vEEaUDIzM1u3Ai1z+XHKn1iKaXjHCxRxqfqrwdtPR25sKqXkJDO5cbGZMVVPh2CAtxB1uAvEgu+q
s51A3Wq47eAWbg+D1Lu3h7k2pyTVyJfILy4i82J6NadBEwlFKqjkmHVylukk7pJUwa9QRTjkfxZp
vhteRdILIGEggjK7aJuwO3FUN8kuG+OucMK44FPeDrdy1aABzlt+zk24UxYDS5vKTAKcZexmQJZs
GjXhadI9yy21GrwyfuJnowy9L/8gqD4fK2wHXkuLoFWK+FBoKpld90xiCAzkUzrqnwI9Qz5EL5V9
XwfqRsyV5xkHP1k1UvVAFtTFvNbmhAmYUuFEkZUS6j/Z2SqG5AuGGNHPPFXSb1oqVq6GK+BJ7pFj
uz3i61fM3BHiCCWjBty73PyiiryPkqDw1xqD9AzbZ7SToPK/C16JOIspeLvaK+sHoag3br7rU2cu
i7JTyKMpKCyvo6xRrbChPml7MqAh2hn+LlIi+fn28K7PUl6daLmDeOXuIz27XLSdkWH3IQcUbLw2
+OZPAco2DaDwDN36If/WtJr//XbE6wmd37mU1LACw2xzee4ETSoEYkUGkTYhkqBlmGlPVjvNAqi0
VPaagsaVkflihwuEh+3226O/ZPGSpmJkqi3eaZ2Qi6GkkoaKmCgmriGwMe0eM/MeSUbkvu0ww8TK
LQaxiI8Ui6Xft+NfH0czqQUwOC0JBR39xQbS6UaQJnNIyEOsnPj7e4yW50EOTHP/5kiUSKkM0cZ5
KbBfflneDrI1JdySCKQamZtNeHvaVkw/f6932hhsTOz1LlVYRybnOnkaB8NiYutIiKOhwS9Gl5Py
FxeIG/cRfKTYowLXZCgjp2P5tegxA4pGRf18e7DXm4XolNIBO+MUSEFsMdgWbcG2JjqosehOKnSc
P6NMfvOWnKPMQqiznTOvvcso7BAThHZPhtgL1jka1cfOHITTPxjKzL0DrM0DYompqcH5CSDSmMh+
Kp4ApCOpGIooTm0cbCs7n+K2TKkSDhTJ9SKLoneqpX3WztKlmLRbJXh6CzXJE1i/4WyajbChvL+y
8unBzc0OFEd4HS3i1b485uX8iQQhUnZJZyaPGnUvHNQH9en2FK6tRVCXM3uaguW1uDIKV7y3UBsx
sH07iRFuBhQTUlce++RU1JV4Lum1P2tVVHwNjKDY2AorJxxp3Oy1B5NAvsIFawgIAfsg+fYGX4Aj
R0XxSTUTXFzEwag+yrKAnLSmhuVHFfOKamPw13kBGRY8CZo9VMCREbtcpLkwFbAuE/pqUy5+5WOE
up3JbEbkrnz0kAMghu9xrdf+wYFD4NlTUSEfoYt8GbgJw7r0Ox4BIxKZjsBPeOrMKfhDMtr4w+0P
vNju7DwLNA+sW3YiTjnLYgLSqVlqqSOM/77WXMmEIS3lXbRxgi6Len+FMTnPkC+ajXIuRwTpKBVD
RQndiB5FYyWt2/kTIqliJDilXouP9BOzc6wIT0j0DXu0Q61nr23euJyvfozF4aYWYt+Q3IZuWKF8
NWhGhW2X2B9yI1Xc2Jp2ua40NruZwhtAxt3tuV7s25fogPtAq0hUUqngXE5ChVJcGBktTsi+3561
Uh93ot92+zzsttoMa5/1dah5X7/OoCfFGLW0C93WssJdoySmKw91vvFZFwffy4DQ9eOTks3x8Fls
EKELYi0Io8D1wsroz4jhqZ5Tj0VcnZQxssQPRtF4b8zm5qCzcMh8KoF643S4HJoyqmWlocns9l7g
PzR4S6E5iWXb7W+1MjSDet4s1AYXx1imyi1EEU+gwORaA4ZWd62UKPGxUVJDPsIJq+H/GAUn/u2g
iwPnZWi0LmeU1qzBsSRM5p7hBaivhy76SAgvZFHRhpNjTMgJVHY8GIOFqHLQ9QcfEbx4Y8RXS4Z+
PmsfXARAe87axZVcdcj1C16mOlrZ+Eex8kZHB/S6EWVxos+kagDipFF8QKRzllCfNgkhr+Sy5Pjh
6HfOqCT5u6gcrJ2gYxSLcuz8OCmyvSJP/sZxfrX9CI2+34yFg0gOyv9y4VhRLnpxlCqOJOaB9CRr
RVd+DptGxugHfEvdbHSj1uKxL7jzyeWAqi/2YDCpyN4KheyMsdrZST+ZLtzCxNHaqXJvL5yVUNTu
LUr4gJvYh4uhFbC5qhg4jePx6tihODy5A/cyR1q5Ra9dZATzBwQFMTsk4fmDWMziJI9ivZSGtmdU
tZjfBR4secHDHUoWDP9909Hj9/o2cqJ0UO57Res3PuLVvpzD0xohqQO5w0q9/IiyYFnkwIHssEjN
gzA1sq3qFYVpUVDID3Jx41V3vSsUMiymlcVDvvhigvTqIC38IfYij2NNTmL1GCdZh/5x0GzsiutR
XURZ2gPElmIJZax4Dh19w/FNPXeSAdSdFFjP/4ez71iOW4e2/SJUMYcpye5WtIJlBU9YsiwTRGIA
AQL4+rf6ju6xTx3XfTMPLFEkQWDvtVewFgGN/71c/u1yQGfPxGyIKHB//3yIuQJ2OlbF0GETixQ7
ztnqIcumORT2pqlU5hN18JsY/xbZ+G9PE8QhwAAo/QF8//5JAGoEfz8hEJ9PxRvlGGNO+v9IB8JL
OmdgnZ1mwVQGBHi++//1ysTkBS0QF9l63M5bHU2qwxRj/gsC9+etQPwAI9+zJKNELf7bM4SZWD/s
rGZdkmDqk1fjBGn7GF/+95v616ucMSKMRAFM/Q5N6Snd6VwR1vk9REhnrrbjGOm/rYc/t4+z4R9a
XMgzMXH9w/rJ9zABXSrWEeunhtIIx9seswvXY1j/3zf0xxF3ZjShpoKVGaJzgUL98+Ws01lhO468
WyAT+wjcyKccnhvHBQnSna4mAh9d+v9zf2BCIHX4bMEM2etvFw14wMOCp8hGumBkDBq7TlTZOBL/
zbDk3x4lviicL+hXgIv8tixyQe0I2RcmOCHd7mYKa8vJVvFbBoLh8b8f5Z9r46zcAwcJiPoZ1vtt
nUdhGf1sKt7Ne4C7pRa/1rT4G/Xgz/eF9YBxxDnd/bxGfttvdRpDng5Vazdnpf9mphC6QDJ6A82r
vo3oLG5VIOvfZmP/dmv/+6q/7RN94SfItfqxS2MbLvYMtDc6y+ova/HPWgRDzbPRIRgyODZ/xwVz
50e+EDQlpDLjveQmNL50qpXZnFzHlPWyGeHPcZHRrX//v787HGLobBPUQCBZ/3NFuqBnQpxDP1Qg
dhjhzvyGb9HfkKR/e4xg3YHnCusU7IvpP6+SMwPGU5+PXZlYe0zniYNDFv8N1/1zyaOnwUZ49nAt
MYv7rama4F+i4o2yLjKhN6dpn3VyDGzl8mKRybb9ZUv88/DC5SBGgUsDuih0k/+8KTuobFlCxro+
LNlp4Et4UPkoOraesara2Priv9/Vv3wCQP0QGXjGzVEe//au6JZlxJY766oS1ca2xZhZlWSqLtCo
IGwGnPIbW2r9f3NjPb8ukLag0i9x1QJn5m8vbyPn4muxrBtw+MD5moXLfjSAdKez63n33/f4Lw8V
xX+BkRw+d5iK/fZQaxX5sh4W1ultQ/SLBc8hbcE+qBCKVMDH5YJn0/g3M65/WTgAVQBj4YCDF0X1
296SlfuutTGyUxiGImol659gc5lehHSyH/99f//yJWBwhc8cQDH0o78zqDZTYgpArezAoS9bG1t4
6Ib65//PRYBEA+eADOz3djiK5wF8vk12IEDvB6qiqEO8QPjLrvXHUwN8gmMMcz9gNmei6z/Xv0Pz
huEimzroypcHAdgdgTjI6qY+/pt/4h8bJNZ7fh6IoUqElOd3dpta1XomVy8dm/L0qQczq78cg4fA
tZv6Nao7nNx7hSSjfV74d7abOm3++5FihPrH/aJ/AlUSBfKZCQJ1+z/vF+0ch+CTLwePBCNowJFe
JBJxb0XQA28LmWkZmmKUQdSw2Vs1Q6hAJSMk5MQY3fXLoR6jWMZfg0w9fR85uBjZ5S6qGe6MpQJC
8dJ7zhTy/YjV5KeSjMApkiA7i7Bm5FZxdoj2IerTlnplYSW+WYx7GVyS2Zo+WTfD+bUtKN3P/5+G
JX1bSiq3X/EWzftLSEKRflllucqfC8820ybGj/GBkWlcEJsUb0xemZmNV1EJcy4Mx5j1r46qDQNy
9HURL484/3rT+phbpFVgwlatt5E4OyWwlIrqGfBOkl0X0FFGP2sN3dM3jh9MWTNBEhWrFk9Glp0V
CDhW3Vz3sr6m0IGJFpNbtX+NPSkglZw21vedxJCct8xv9frNZenK7tYpJ+mFqOseACHuZcrfFuFN
Grp02V2ZX6xLGEJ62CwDFtOKSMCV9WKlmuynTYJqhSxYhHPCbvE8ICtbWS+1bLxHkG430T71j5MJ
sfopZlUkI/LBCvayaLSzthPrNJMv4MtO/ZdtrAPIzibWIxoVq/GnFmCWvMZmiCBoTYNS4etczOC0
1gNsIw5OR8vWmjIX7EGfPWhkR1Ji6pe896X+PhuEipkWIJMyX/XEALoiUJ2JlaKV7ev4giKtwj0i
t2Xj6CKGYBbMK1lEMiQ1J6sJL4UrxfBtzCu7kCPcA3YrLoWxhj6U1MzWNpDMVNnDvpfI+Gg2Meye
teepLGrs0RduelnhdIb8V6rmensOPt1714w2D+Sh0ukgPjKc2MnQSkKqQXdhX1kCny4b5ebrOUU4
/0xCyAYOUFovcE2kgy2RKzZWdo11680yrQgXq6d9wOXxIddPrPcSnHUzF8hm8UOu1FuV84jxBnwJ
6nG2CFPu37FX2iRqNqQvh/vFVKBBnoiuvU4RyaXWfGj5sKVmRUpcSPpPvaokx1LuCw3ZAnxj4+i1
ynzQ0KtniOhC/AYji3+baR3iqz2Zs/ANgS9m+IowsE09QdnqRJfXPYKkIIsIZVMhFFB1dhp9dHt2
C4bYH2B8eBZIhIi2bjIFLr7uS3njPSuy541VJhyrfsIO1IJ2p2mEIMEpHsjF4gUmr41aMu/fVCbx
oR5l5GHR0JQ8CqCIKEbUGl2nayLnug09jJ/2k6IkL0Ub0QowIKx/OWYB14ZAxVm3MdxEw8+cEkyx
up5qsICaePLRlB1BEVIV1HIxCT5uWBTU/gaGJWFDA0V5r26SZCBgqcLjB7Tkxk/VwN/zZXXz2JZD
FKLHAoWurqDa8X3NmrCBImMabLC5+ZDMM0obkgxIumzPfAitr8pYLNn2hU9RLtbLdRN0NqfVQRas
W4umoCy6OS36/EalrJAIyKxGqujlht2agSMd19uMuDm55m2SETLzdjR7NSeXIZXYvr7BQdkb86h4
uvD6oFVd7vG3tZ/Q+6C6g/0lO88kSXkL1zznriuQhnRymIeQIdS59iY+aO1hCdTVZGfrvWSLXy4W
eHmMDIzCbeKsgdv5Xv+sZIKZx3Fjvvi1zeNeXscR19H3ckz09CRLqPHB+gNZCcRDiEinn0mKPblJ
LKqFdnejtddRMZf9k0eDbJ6jbVrFSYihSK41Im50i+0r+lFuEuZGo/Hz5doHcdrzPoZBxL4MCGIf
9uG26BN6V0N5cExEze8wV5sx75FlrfOnaswlPwBuWl0CG2k60btitjuEu3O6ZOQ1SYF9f+CexvR1
g88iYAFDSH3Cn4WRQ0y58S14CCI9gW4diWvtVZ93yHUxGZLV6mR5TU1SkaghiBCYb0jOa/GY8FEs
N8iyyfv7JRudv8F+N7+GLPb0eVBIrf4ow1jJB8ZJVT5sSxTqV3CBlumoJzKWHY1n60+oVf3WWKdA
Gj0sRPafU63j9R601VEe3TC6+geW7IQ118eguzyssP9VP+s+YwVEhSuew2EKdk0/x8wCnW7ItCZY
1VgjkXvIkbdGXxGdgngNhUi9cEUJyyDrz1wv+HM/VFukLrJdF7o8RghcdPGFQ6PQuzbsCJn8ZSu/
R5+WZ4vaG7rFmSGt3kiW/EhW50wK9bxyReig0LBatHBBGgbX1DUd4eO6T/TMSl3hS+t0Cz/cRX2W
RkaRQLTToqGUpUOy1e9IDo7m53LMJFwBiwkLnTZghoUiafnkU4TumdjITWEjRTTFCa7BAvpzzD2W
WzhN7mkDogzsgqrJYT8H9UCbNwle6NpAQzUabI0xj1sOHgg4lvFEMEhy0whaUcTHrHp2Awanz/1O
5M9BzawCWiksBxo8x88xAWLWpliLaVsuwyo/tAnVIwheOLFrGVH3UKjdXQz4vvobTlOKnCZDl9cq
xuC30anlbxqknkfhJ/azQLicvJgnlz7M+148QHQ6bP9zLLwNVbw66Bx1AQvzhZqvqBQqQNI0r+EK
idj6/QQzk36Do2ufuTad6jW/CBrZFg3ovvJ5iku8LB/I5br6KO6AjdKooTPcDloQ8WBFkC9CsCMr
8v4G3Y2XzSxFeB8Jzu/LeUsWRAJTvYOCvW2I4lhifiwqj8S2LFLDCc0HHENmz+cIpLZ+QZi8VFPU
WpDGuxXTC3Pacby9peBiinbpcca0OfJ4MxyoAq5AFqzWrfXrbvilHm3pm8xW4I7BKa4e4B7kdtsh
1E+7qwGWF75BGH15weWKZC2oYaq4iwiOoSY+X6o1U8LB+YhNn7VrPBWkS13iYpDsBvqI7S550emE
XN4ERpffMlYO3/LB9b8oJjsP8QrrEzwRQqIjHSfMkaJyjfA9TKzemxppknUD05i5uJl76fjDNAWF
tPJMs/nSTdDoHE26Je4bh8p86bKlJGPDcr1jDDRhaRa6ltmh91U0tQw/c3d+D0DCPZ8sgpn6JGlR
o0xllwXUIuAleolDhJXSNgV8lt/rPZfXQzoFhLeVeFANVDlbehpJWKAoR9bM9wmvZmzHXZBjCtU3
YuZgYnAEfDgr0P4kT1o0O/LIMoF/AoZFDT7wCjEeKYuH55Uz1l9kQ78ncHWnIHwWrKqnFtmn8x0X
RUWPZcLgZ1Nrg2jBdNIRRvp14AhjQ0Yg0B4LZm9DckQI4tOXUX4IRiIMsNQy/yr5wOJ2LwhMjaUr
ZyQT08W527wcZsish7QeWjXsZdxNeJ/zlyVEycUE5+D8ckqF6/FDJEN1WZo4NCmUQbbZyg2bmQ5j
Jo5KWnKXgFo1/Ygn5JGSCntmsxTODB0dFvxahPXV/GBri4qvKMd8AFNclde1YGV2qgT2cJTuteKf
PKRu/yxguvIqxYzzhNERSbtK1/V63MIQ4V5irVpUSxlsH3fQPa56t+bPSe51daV66AAQ7GWHx1AO
CtleYN5fO4T92cbuO4o8G+Y66YopG1wL06kalovUjfd+SZLvOqvpzSgmmTVblA4bNsOaja3qLTbG
PcTZtzWJ/HeCvOC6IQizjB8Ts8GuIAfFQb7ydbHAxrjejPqCz9IHGC06nHxFP0bknqKufQqGwNYl
mpLxeopzU7eIscT/03ziQzcMtEov8KpyewyG7hpLVdWPFnITdujdiNjZATNqejHuZCmOHFQd3ljI
mMpjj6hBB6CxR8AknVz8mu3kTIiCmpMdAULqQ51asEF7R/tTSGwED6J8GOSJoJ6eXyhL92auSj62
ejDYuzDZKLlESmQ9y4sVetd7YG+J6DA/svHlUm4xFGIEPQu+r2Ik9gQXTccuVFat8zVqFXRtHK+F
XQBkwO+JmMl1p10GKTwELPQFY335mcRh+Ennaf8J6xf6vg9c3Kgc3Lxjii79PjDDn1RPhOsiLKhX
k6pInyKeqqeVkwh7poxDeixdIVAURH1NuhwFRXoqYhfzy1RI/YQ5ez6EFv2+3NqwqfRxhcbOI0l1
mDvaswJnAcGp1YLGC2+sXmTViGJQoUG1IkXIoGcwpggQM9VHcPSj9UjKtXTfmKorfrllHOXwZqPy
EASCBvBBjCrdDjO86hCPSQh9Y0gKIw1Ia5F8YsbvurNy6dMTtuIJGappD4kvfLkhuzF10WSBwScA
RIr6V7Qm7le0kfqXhkW0aSzrF9+ayOQYWlYa5xkIdmJEHyKTQ5+jPQfv5WwW6WK5vO/7DqXLQFPJ
G12H9APDEvRAWx0jf24j67eqL6cfUnmSXqVQp59gflyNLeDsdYEPB1DgI5QrfG5Z3oN7QukSP9up
t/hcpjB8L9S8fylC1r/XmycPJk3MQ03qnZ9mVDygT245VMWlxNDpMDK2HPdM6vFQx67qYeuP0Kd9
ES46Ii/X/ShhR8qbnPjtg6XwSIDLi0qLrndJeRLRaiMAN0N411FmIZWfK+UuLNfpjx1xxCU0PX56
n7F5hEOJkNbbhCXRr8TI/YsldsZSWnTxbgfBnmgOhwxIGoW+MsWAEinHMMU2HhwfeyFAwvXdso/y
l1si8kNpxxLsb95/HacNliwaCTz0jo1LhrGptOozFnr17e5rzg+eZEKAuSnMNZFuXtEg+OXXUGT9
d5/Ow4PBEX5fIO73jW45wjssntpHuWzrtZNLjFpf4Z038F9xcSs4QR0oBD3LdjMN2kKUeQHDW0rN
l3pFG94wxzd0VZ6e24QqH+/jRDp1nKMxByIfw83oaLW3pmHLmJcnTC7jNySG5wW8STS5y9Ycn3sC
2WUJoAo9fOcga1+brHRImGFgElSYNhFfH/bUQcLBnZuuAma+2XFP0NgfkmXD2HPLtu1UMjxrRNXK
rWgnk5ihMbrEIuttlt31S0WfwbwQT8jKBA6Exs/oJp3rJWp6ODAUSHyt3CMXQ/5pp1rc7nrUw5Wj
JM0OdYUi5rg6iSRjbs4TlaiPkZG7lGI7OlfXTzjTp7Gz+aiuGRTe2+U6ieL7ZFNy6xgJ+TGuKH0Z
ULCaq3JY60da9x750ppDY6BTl/etp8tyqGKHVJolzhRrh2zOflZL6kACUr24zsIanrPdzFu7IvRG
we7Ik73xeDMnxL9F+9FaGl77wXl3g90il8c64clBZtW2t0jTsihn5wHNXY+bx9PxtX9F050+5Twd
vvIVQt9m3IAuNQMCdvou4T76JUYmryH3O2/hQK+Q9GbHuWyhotnuy81bGPfC2wEPIOxFGyDLuoOn
W+ow8wmFahAFXCyHAWV73hKRRZe53XGbNUQQ8IGUe1k2+J6zD0z4+m/RnOmXDHT67xgTIK1SGOba
jYr6pdrt9BNIoLhfzSx/sDyklxNuc20xJUf76zAlglsGOP/gwe11f4lUTVHhusZjRZF+Q8JwlNqk
ibN+wZPFngEcJMn1o4C5B5r9BKwI7J7lcm/Rpe4NTHxZfD17kn+3Xue3ZcHWdzHy7CUtMUJrdCa2
H1zDdapxAvhnq+VUSGx7TCTNanT1jgkzimSD2LebkC9ubTwe4i0co6MR0ipnbmYzoEiJYhN3SKUX
E2RdCykaj77jjYCa9YaMnQx/dzJDEgLixnTKZtbzxtvVoQWCrBTNfxin5dRLst/21dl9usAodmsW
iuTxVlNkYB5QNXnVZjqwV9D0+/vEFLttJPqj0MrhXLUtmZ0uVAE/wgZpxuXUDudgkqtq9et7Yn32
VIQaKdqaBPUwqa16yYc09pc1H/jTvLHpYwPF+hb2EZM/jsWI2PQJLhivkQOQiuCmdYT4f1ziR2EV
joCewjYTW2xRPjgVlS8mndHKgUWcPVNrcXTsk4fqp1i5E1cbIpivhUaTjNo3RXxJqmLyOlYTbOnQ
M/RoSKsMRk4aVcuNDGrTzZwJpMLjEy9+ELKL4UCXHcZHDB1xKwbO7xQCSQfgQJgpn8TSs5s1wCgB
+Rt1fFlpXn4OSDS+An8dVYywKDHirXJPQJbLpQMNud9bV5GKdlU+g0AvAIjBKhO6+dsRw6aPXWx1
cdy2KTnmhUVFrzYWxjZZV/0WLXt9X4DcB669giVJw3MpECgM78drjDKnvMHgbfw6SL7N7bypRMCQ
1aL2qmAalTZbOsivpiYlItv3OQ3tlsXuJqsGX+Mo3MbHCi68JRLHt7E8ppWJj3jHSJhlGlJnmWjy
BnIR5O4QvSe6y0WubwTUcfsFx5ToqST7Sq/gGonDkaKsRph47MhFTSNnT9Ewl2W35hVU6vmATQbR
0eVVH4twpzex1IfgKL/2yq9I5l5znzY18fpu3AucaqocMMYUZlUXY4lB0SGAefia93N4X2oXLR3e
Ib8xbkvirt41FrfgvXxBjsf8o5YiQ8IYKpQPDBn8LSv3jXbomdWXzXki7iNYMWzDYz0DBO7clG6w
f+/NuL7FqZcoO0aTmS9ZnwwI0VDIV/nBA4l0o/iGr4BUG95ChFIdnaFOeXo6EwAgcR7X+qPIz2Hq
y6rD/rb3Jv5aYXB44W1E8eEEa14nudcf0kyCHqtYqWcYp2cvZiJsbfeUyLdoxKnbROi4vwXCapgu
FfV0jNcCq7QuzC4ORJu6OjiDNPWLFVi3bhKVxeFmEDVqloC2+GuRacCLsUvgDJACwBbdOPPKNbAq
nZCJWrEJidN1Kr9yB+MEWKcHRRq3Uve2ZQxlKIIvVXmQAn9MN9kFl3bVglj4KHh3i+J5QS+LaOCl
lUD0xgPU+VICU5uXd+JtUQ0fIpwhBR8ty0PFSFUdEtj1oNjYF7+3YcwVkKnSbFFLvAsTDpV5ndsJ
M+1fiS8j2P7iPYzJRV7v8/elN3A5RYz3krbAmNHW+DI1QHpIMc1XOkuIgEVnmgIdgrEeUOJ1prJV
IeT3hu38xkZkV53bdrRCSFYt0F+5FSbydN3m/ZgkqDHAgBlAA5azXDkGNE49stUkEf67nb7EKUPd
5lmI5DEA9c3aQo3FgxRgDTTOmxmIG5flF1jSpWWzzYX5CUG8Mw3AkGjuCrzmuZMroQCsEH91bz2M
cRoAJTw6WbB29y53cOdsc1lXK5ZOkt2KvtePGKpI9PZItojP27d4H11msE3DWw0/PqKabkgf26ck
ZPXdLN3mTqDrs3uthjjpcnhEPGw1zBvh573B8V0Ve4JxVUwNKoFIJzE5mhqQ0bOkbADHgw02bqdJ
jeGWZxytWo5jUDbVZnJ3mAOBcScRYRfX41rFF+s8b7aZMf9/olhVG5g1oqLAKrJpwGY84oMawZUZ
ECanORrRIh9OZkir0MGYeMYos2fbgIQxWfVtYXr3nimxRSeKLvUSmGp6N5V78Ysixtxg3xo232os
oLLJhQjRkYeBh27tE/u050SSJo5Hr+GNkQmEytGxlO0sZxC+PbyxXAXSRRp2wLzgw/IvO/zT8nMM
/L6g2t+rWwyJ1m89KHIRBv6AQuBluwegfvGGQcC4L4G0vtfgj8YjziYRZ+IHoWMAKJnV/KnHhH4+
yJLUvkW+WHVfO4bKCeqilTZRpANwZi/4ZZ8m0PVuDmOZJoczg+pKVK5razDjk3iTAeGCpcvytc3Z
nH2t1xh9dQzR5SNGPjEgjCU2KISM4QiCrTCT8uU235sRJW8HP25+KTlFjWEHYpfO7tT+SHofCdR7
+3zDuBTxZbL15GkNWfoA7i8SWvKtr4GwRmpdDxLTvtsw5QDA6JBv3/5nyNDUtp4/E7O6O6L67Zn0
0yIO9bqwzzzlOE5n68KPHanSd6lX9HOZYOGB5iDt72avEPwc91OCcKoMfr0W6NNFmUzJR2+w5eFW
scYwFw2mM06t30tFAMyHYOG4ZSoqIEmGlQv82lh+wDmX3WGCph/Rqoa5TYfcv4IkTb4rTCZwkNXU
6UaYmLBbuJVinjRsi/06+4p68P0DYg/mpFw/1wieLajWi08CE8eoRTNafUmSnQHpXZ3+RpxEZU03
E90Kdt5pHKX9g8LxubX7FttrDEegvgWRuSRNP+q4uHV5yAqMZqR4cLFHvYtLqrvEkQK2hhbnXVVa
bFZrWUSPS6XYcq37MnEYMEmbd0MpAFPCQrtKLsySwSorh8NK3m2x8r/whM6bFUpN3s6AU5/jnQIs
5fDH25s8A+wxwJokv8AhGAPXlj0G4UmQ0wM/Ow0ca5X4G2x7KWIt4UHkm6Ii06+eyCxrlaMLWmGb
To/M1Qjxwrx81Mc6UzB9SdwYP6woQaK2AMvnXqP8X7EdVBTDJ8hHDJTxLlpRZA8O7u+9nG3DsddB
nmTH0l9mUAR+VjljWSNjk8kWi8S/WsPI0xCzdcQoeF3fFe+B1loklvDGODvfF7Am/Vhx8twBaY7v
4dc7JfcLuPA9IDvJEb1xnhA7puL1pQfyF51Y6s29jGItr/tiC6FZ8HkVR4gRMf9j5Gx4fPYaPkit
Ucun1ViPYPNoMrag2NIfigObhYhyRUNLVs4xJpo5vU+ghjWHdbPrYeg1RvwOVD48X5+gqFhFVDzw
mHMkPocBtcIENuiPiGMwfVAaW3HrmcOKraao/LWlkX/MvLH6eq4KHDlIf9JxW9rcvQMHL7NWg4R8
KmB7Sy/HDPT48zEHP8wZqZIo/6YBuB1saJK+BawbXpmz8Zvnooobm3ByDdH79FmUO4BnmDzDbJVh
BPxiRGlLEAkkZvj5UC6XUhP8ZrnaBSVtVoq8XXiV/8LcI8e0AyyC87BYQnOlMo02C6bx0QewE8Di
CpuabTnGh8mNX2X0TZBsSQ4EwThju4+Y8gNH7jGMLynw3w5ectMj31P/w4HJ9YYbQkILmg2hDiXU
IUWbLVZvJwTbFlcAfKK9mbCEvqJaUqIb0p5E7VQFkp6Q0Ze+Rbkan8FSpd8NsNk3WHnG9IQ5tXxe
2Jh/rmGirkHREwHzx2zuxzwt2a2rq2VfD7mt4w8Qx+fQJD2DCQCSKDJ+GXGxv6gwrPlVQlW/dhvY
IFjIEHb+wvfoFqCHC+bEoxUeJR6YN8uh4ITOB72O2bWG2wTGTU5ln30qgQTEU9V3dN2L/ViOAWzC
0eQRQccwET3cDjmTuGdMBkjrsF79cTImFa3Eu7tS8RRhlgxB5ief9+1hRqL40pFe93nrAVenh1zl
jrVzJNLoOvRi7RsYE+VvJHGYCKmhSjYEiJXhseQknpFZS4i/HFeaPIEOC2eAKKaoDZC0ztppi4HO
DOc6AKGo/XwnVDoLbO67+kpWjMdwSiPtownxXD5EurDDcSeb/F7OqI7aUQGsbgQZcpxniZiftsXl
P6G5AD6juJnKZt2gx8leMzgZxrep90m44Ws2kiblPdAmO+TlHbi6M+8qnMOho1t1ztoluYG8zsId
4jggvEWcerGU7DrB9gHkmS5bfEAg0vjE+OAB9+Q7GQ8TeEkZ4LwEsPK8FaFNvAF7OOaBP0PXVchG
ws9iwI+voStUErYGRyRmHAYnzaeGgW7WYeITXxW77Dk8LOviquAVcQD0d/eV4lE+zyFAZOxYPU4t
4dj7WksT5OISNS3zEZDQcK/p2Z9D7EX8TCJqXqD3wOenTA8Cipez0x3NKp21A5lBxcj6KrnUDN/f
O3gC2CCzUmHQlaTYbDnKLHycKlnnJh4BMcDcBM4r8E3UaGLHYtmQCyTjFJHA8H3DaYA08MyhiWgy
OKYeld0Iu8n93hdN5SI3NoOFM1ErFADVi8oX+eecL/RFYUuheAiluZxilERdBQ5U9oiIPXPjs2ga
b1CdFTf7HJXqhEhoO7Z5LkGqQeUAtCaObbx20iYEAEwYsHhonk9v1hvcyJKOw4NE0/Xi0BNA4kMm
GByEau6/8WqYPdSUoQQNCEcHO2DUu17PM8qUowSmzluBSDUD+Wy6fonNPn0QQfLx2iVFfgH1tfko
rMgPUULN8gXQPWZeG0SRHpvSUvyqrRx/esxWPwXQ1+dsLkCd6Gc4+rQpH1C9bQtK8260c3a3ge4B
hhhmsPBRst5h5GAz3voEFuQw3dzX95JN2ASRP4nNfdm2cm0ZHzVexV5i6W/VrLJGUZ0916AevVMR
u+doKSvTyES5dwWD6Lhj1JL/x9l5LUWuZVv0ixQhb15l0kGSuKoCXhRQRt57ff0d4jzcQmSQUd2n
u08ZYOd2ay8z51x3+BMzCJWKD2+Y2TdV7ervyViIlo2tlmI4UOBOQI6pNU7LFJQRkkd6PhO7zU1r
RwjAkGpAPZ40V2nUpi11o/qqSa36TRGN7k4VCFDtxuybn7IY5PgjBEGl61PW3GdMEJfO75SrCJdU
d9KobwowK2hWI/apIEzbl4AsuPpZueUtDN8MddBapKWnWUHnqYp0VwUJE7k+Cyg5wHIN7qrPOXAi
WYmALaMZRv28BLBlLzYZ0gobrNo1LaWuc5N0JxW5pPyOwFT6Kxn7ugCFP6enPMXz9KY+KClrUd7N
XCvu1XEzxpS1q1HPKmcyEpWZ+bBEvdnngaE2bo4vZSImrwQE8LijTJgfZWkSYa0I1fCoBlN8L0+9
RNJIGqjC8XwUpQNeg8p0arbFqW/96iZTZeVbnRPp35F2UlSnAnn1MsGsew5ofv7Q6AkuNgjwGExY
5CvfQ20qYOBPkXIjUOYOd0UeVK9hXywIRGKQxB6QcWu3nZgngt13Fu+FMHUx5SSKiY+6DqglDpG5
tIcqb3/3EC5edELQAH9D4X4qOAkBGUhpnuzQHFWwV1bS6Y5MC/C7yJhpXx1lyE3bXSdLd6MyjHcZ
zchK0pVq/AqKjsBjavtfI2hiemk3y8ltGjUqdnOZ5E8FRWAOsZWOkSOQDBBt6gWhZZNoIv0060l4
DNsyN5xalWve3oFv2lSh2oW08whJiKeiMKU7NfMBCzXB2N4FjQ+sIl7A9baqDuEEBq0TnojH05Oi
kd5mtWPhVNZtcAuFBsFcX8rVvSy15H3rBZbEJdM0RCGTojNdg0TadxKJ5bMYDLLmGWJKLravI+kG
nGSuO3BJSFYRo+lUomPJmBxsK4AN3K38bupoCeMKlcImhy3lY5djD7MjAKX3JIRKObpKOIm7QaDk
jt0Oxlez1PxHDc+FddKF7k1SZir7kOAj2spI2kRwLgzhd8mPNP+ADOtwyitUYjYcf4wZcDzex0Kj
yR5V174K8NaVpYt9Vuo8D1NRXwsq9sQ22qBN3DZVq9kW9Mk/wbHo73vZbN96tVXrnYROyFWeUn7H
Wyt8SpGq9krubsDkGXWwKxRY9eRfo2IrDhVonlEVyium2gBnMOQwdCZoVr8jfQDSIqDZvmnETP9T
qmGqe0Ld56+LSSAyo86Bdjfew97wxwwpQ2qkz5U5SHAcQiWgATI4N1Iy5CVu0hpCAZAY3b+ZjZQO
fjPJN/AH4Vz0ruUXQYkbpEaHWcvJWpc+2HSSFiA+NpUwJTeJVfBgZlU2yByfWjkkGnUmdG7EIiVu
0pN7sR3jn0MxGy8hGHBAmKEi/mjmikBIS1HaUccQhE0gi/AKg070ccX1XvnBKYyvgd//HP0mrRwl
L/HwjAif3JhNGRXIPBV3sVyCYRpnCpsY6bgKvdjETbd7gejTjinRATCyBnkPECc0PdTt6MWk54Ly
mgOAw0IpPL1x3i/dpyuuBMl+67aRS+W2JOucu/6gDM+VzEvJ4VOHNzmnvZAdJ7F+1TfgvezcKqLv
w0SJjDzUoB3hXQ+ccACVodcB5qvRgypVIngjoXKh15J4YONq8BnJKDwm1hgAXltAh4VGh6FtX/UR
RtbPn2uIo0+D0hQ3uRiNyi5OS3GTC2OrbjGoVeIYbdGGKkgJ0oC0/yGHkPaHJKfmKS3VQ3B0pm3A
Iu13o6Vl1BiySG+cWpBJ8NIYBXID2viUtHsl4T6xCX4NdqnVdIodvXlMhogOZo1CSvwIkYyMQT4m
ukEvmRpMLqkIMhS8FWHr9aWRKhs6A5HGjjulfipiefg95Lw7qHBRZXbjdqoeDEsS0mvAvdFVjLXI
HGNYIinqynwIIDJRYBv4W09ojwpXMBUpXRvzEL+qoTr8pq7HqHXSJJZLrio1T7WakQSmo+FMDIDm
LZXW3NTqH3DfSu0q1IroG0CDtsXJ6ssOmEwkgBMZoa8kTl2CutoFpNGaayi0zbEHXN45JimueUdH
xDIKT9RXR/kRVMX8hrPVg4EfDdVvvrdBAv3Dq5HdMvYC5ftXlL2HpzFQxm5LHd4sXItIGFxFJ6AI
SUxNQjswZuHZQgYNqS5Tt27CLrFCEGChiUNdFA8NpXvAVGIkvglAInJ3jhLN9wCEWMChCEczV23A
BVHdXi6A2k0IFMq52VeOWQuNjldtgC6jumc9tkVl3s2dMogUKGemCSu52oKuHY5z38yk3GYsg0sx
pLsPAEp31ISkpCKPaSbfIyQRFLcrihqlH5B/OJZJNpEfbjRMTi0lBPomYBAJmFjbtmBRhDChrCBw
bKjZIt2YlLPh7yryyRHCRDi1Dm2IKRNSdsv1DVJjJXpMyKeZG7L1CW+TIlOOU4GOoxNXz4TIed3L
FKpozvqAwzj0Xohq6gEBGYmsipgLAgFxw/EdRhElhSrOJt9OJsw7tUOSPHuUwAmgAZkY4LnmWHrV
EjmBM5wjnYnCap+Mbqb06q9wzrGBQkT3GVtQMvKyVgzu1+4w1vd1WqXfACMqpUckP37vgzAL9wLO
NvWMqFTujEBGVWuUSk5kq+etRKVQko4DDs1rFffmAxLBFoAjuhP5XmrN0DhnRW5vajOSX8JCNjQ3
jkdxP2tBUZ5qq6jvhinXRPAaJqj1YnHnM1+h+bUqdiDB8MIF2Na53vzIw5TYNkYKFCMPcNN3yYar
d5gD6kbwyoDhKnkqCADehO4WMzX3jhIn4BrLGBWjoXp/B9TW6u1CLNojppHaMNgh/wn2RbqbUFMd
XUAOlASB9lTPE5y4xq0AuVUH+qSIf4IxN5WtKJDXc0gNSDwlok7HSIyLYHrSoBByIjbe/soCuRlw
opPgO7q6/d0U1j0vTKkHr2EVzX8kn2rJJqmt5M3ika49nYtF9aGKzQrZmdgACzrhZjqceArcaihw
b2Au4OwRbic/ycvnr0VpRIMtIQf/ncoteZmhaadjUQzWK3ovIHioEmsVmf85BqasCOavNM7mt4h4
illJKTi2LjN61YmjWGuXEp7WO2JkpC8Req406pFmKPYq2TkqndHC42h6C4BoXswZgBNRZPMDSnWH
Zpjk1hYNedC4B6oQgiyKg9ozSwuoNW8LLZTMQJ0DhyJsdUOnMXFyDVEXr7Ugp8FAJA1pscVnTH5U
BVYZJw64USeXmH5AjtlPIKbxLVzWFmxhJGeCBwrcv22xT6GDay8RmkVF9yCDD/9WUq951HRqByqv
43VWpMp9nCpqflfFQ4e8jhX10042+/GhCZsG6dO5VpD+KdPW306FEt93pdKQbRomiCqTOJNhxHdB
KHWWzcT0iIwE3YvUghBxbCq9duWWW+MFbTRiH62hzve5OsodFNxBNS3yqRr2QVNa/jqEwvOTdt2l
4KCvVqBiEEtT/GYWgCW2yGL0/rEnrgHEZfj9/QhW7rdKOMBWS4uASx6QX/fVEAjZBOoFSEMrpm9D
PfqPPt79L4SgltTqNA4qhgAf0IN+ozzDAQHdQZN39bmKRh7yupWsbZUOCZVVWEHZbgTTeU98UtLI
OJYbIPMahKBBmivJaVLYh3Yiy2kKqoTEiOv7UGPwIw3jlnw03qYGE+AqroHcuREtJU0KBh3PE4Aa
5bs8VdHbaILmddLUwMuF8VdXTiWa/m0eq2CLiiHByaXUGiabQsn0ByGTAe90CIXcNoLUzk5l+t1g
Q3kDwVQaYvEoR0b9AtRsFjajMdXbEHbu7JpB5R84UmrqJXWGZ5oKSn4nma15T7PG4tlUKk3Y9AAJ
fndSNL71IeUmkiyxetPMQnKPMAfrNHAeXkuK6yPx5lDta0hXvSeh+d46fC7xUZ2tcjcKsQ8ghuTp
ryaJguepDOKXrJ2UbxlB76+uGrOIcixnzpaVTJjsAFw2ySQNDQu7AQf/I02pzkhJ5pPDzfqZgrxh
lluw9pXsECMFBa8hdThcZsD5dqegmOYFdWvctLEmjBjwVNLIAsbxU10m0aPlJ9YtBURyL4Pvz8KS
6hoL29QFSC5jpBIETNi7V1wJAhAZvKXdFtAebChW/psekrTYNFYVq+4EKsIC8dVOB3XWM1QvxOXd
icUqjTy1D0nQpmA7FE/KTOO0RKAapqab903R0Oje73qyfCg5yddNP6vfggTbZiN1GdGHiGBlY9Yl
Tg4yzvWfAerfdVRlrez2tUjlPDLhF9iIF429o7VVkNr9PAlPUBHZ+XFCHN2MZulRGQ1EWyoQmDL7
h+NGL51ChoKT5NZdm/izZhO2h7gSviRxTURZ+DZEyvzNj/pOAhq+ZJyRhete1bhRKmceyMg4M70o
/EVhcKL0RvboNmNXBYC0BNj2pBjSEeJYfWNaAdBjQ8rw9wPVaGkZZZXDiP2nUC83E0XfeUwGfwNk
VA12qdRYd0IeoqdhWdTur5R+oK5BYbxx/XaaGsgWeAB7OVYtwW5aOiq3eS0QobYU4D1C2DyGkBgX
xZ08SQAEQI810Gl8jhNlkr7zqjGcSrcWR0l1zBkytDOKXffaK4MweENXS/HGCq2EmxZaOv4XUNQZ
IF0QxK5EcjD6NQakaLxuFqTeyQqo8LhrUwL4wqrk6IASmZUdhz4yb7UoSStX6ecUwlYB2u4E+Yfy
dgdjgcWolOyXlORSs5nC2R/daSR5tQlC3GVXYhVrd8a043HE1KtY2LQUJPJDsn8fVQYeRkUTDAHI
Z49rMnGFf6f5SFv1CAbIfdFOaL1UNAQ40hqhfQI9q1KOLBr9WGlUoB1lnkpAxmYZo8qo+hIYXOyZ
LVBSuZF8CfDLSE4VTN4AQNtNYRL9Kvxy+lakUnxSwaeLC3SQLDJ5WYPwtCj/mH5PSEiGl6wheUT8
sFijdNMaqfiCHzi0DoFLjmPa1+ZJKpVK2vqqOb8EwiAeIZv24hW0MuXXoEnKkqZJAWrSVSjYkyIO
ZyqlYn6CZqBIoPmVLqTgTqsDBzgQN8oYY/EupP1B4hSqyIb1oqg9dk1NgbnqdAq9idhY+0kI2mE7
sN8PM+/6uFPJcezjOqQSrvRkk1A7666BRvB2FuBQbvAZeERSsSl6e25IbWzNqKpJZcnwCh7ITqY4
JkUvg5zKE/NOzwpgsTxCwalKwRTbPav8A6x6f1rCP0A5YgozTBCK5hbGpP8zKcklO70yEneoo5kC
GKG5yrMVTlzmoAwnA6RWShIji5HY9dDFU3+mpN3QiJXL8DFU85Z4WLSqZxSH9JR0W57+DKSqBg/h
JySX4HWnJej0vHyUCrAAWFqQGKqG+rEdNbQmd7nF04s16XOPd6+AChlI2mrgcXAmQUyr6b0awWpw
qEfpb5pZG3e8TI2yKfyAijdHt/bENqhx/OtSKZ3FOk8bOSbl48VjS0JbM2cgkqGZnRY06uSGYzUe
8WfyRt8F1LYnL0SToEJkrhKOTc9bukuKQtmbZEpk20RqnsC+GEvp1EAL/FX74nzSIzNt7QGIRbdT
i9mMrswyyiXS80FrXM+tnpbfiRCE74JFWpQiUCmCztdj/N12KKXnNJ/JqEn49fFPK4h7wSYQA6Ho
S1CmtmUFZvyHQb9Qi4KLlWsYBoUkGSjbgBQ88J9o+ga2tKfbhgVxaaOUMHnsopvoQvs123lREvhL
N53uajj5dC6RYGPJ5CBX1O5UmjSrAvZDOViVX4Su8O0uqbqtkQzjrSCkSL0KfsB2tZ2bJp20/Xr4
Nd17GZ4urZDxTURsqYF9ZFrDYK1bQCuZDfGKwCgFyNztRDCCCtzO8kSFwrJnTQ2u6jEFFPz14Oue
Yu+Tp8ouUnNU9EU95ePodAnTNQp3uZ34PLNeLflcnoyGgF5CfBEBaiKfFsDLpnoeEVvBEPWSHKwJ
/gzp7kpvny58orVowPt6/PWJVgIrwJ39qs7YjqBQsb0UMN04sGQHr+l7hVOMsaESXsNF89J20FD3
MqdtnpMLkIcAYPhE8gE0iXVhpdaE+PePRfvCRfNWUj7pilUjVrlTCY7zLCDxCnMuANaRkpdMmkIv
/lEZYhlt0fcwFm1TEDErwZ5yUHMavIMDAQxsvqmRoQCOgyxl2NGojW+0+JUviGGdO4YI7km6tpxB
SVsJXwCPbIqkoQoPGVC+1QGZ4PBKIHFbcdyDnbO2ZQ5zu1D0f2v+wAlUdXDG+nICGV9anUCzgH8I
+oViHzJ4EK4qXIryW6Zi//fkhChsf33APk/043ir8zXpArSUsoR2mIvDIqk6HSfGvQKNoYAUr1q3
Mqvq3tLSYPP1yJ9PNiMjPaMhaWzQjWr5ZH9JZDWTVkiRysmmP5J4CEC28tiWxT8qtbyvJy0COTbw
MUjnfByFoSPFqrjRyiC1B20BvpmZdKAkPzwYoK0vnJvP9wLtbcwHtWPKgezmx+FM1fKtTOCk1i0v
WEuS2CH3+ANqjbT7evnWainLxIjh6ENOsQd132V5/1o+iFx1PUa8DX4lV3u8FphYkIcjB3gnnOSa
xO6FhutnR1SQYYL/DjFhrV0oEWtXWcedL0Nh+OlPpLysNl5yinWY3KLVeEkb6dwJoXGCCQ3CRPxp
rS0+0A9CpW5LXQCVi8GJh6k1ndJo+vx/OIo0IEIRXlJVdm21lhFQcrwI1nKujAqkc2uBOBqrC6Oc
Wz/EyiWgU/RAARH/cccGA5RuEjJKCz5Ah1hozbs4lGtvJNtK/Z6s2NdH5NxhtEQL7ACuGNZsdcP0
otaCyVyOiNRbd0OOLIgzBoEheF2KI3PBkqwlipYDaSmGyCqqaEasm5QUVpfi98I7rqUge40o7YEO
TQCuzOW12eRLM2Kh7b9/PcUz5ouHAQkyCVtJ2zf545rOvjkrGhBRG0UB+JyS4W+bicyrksWbKvVN
8hGKulUV4I4XpntmN5GApdaMIhPGRV05Kr0cFaFZcdMbvzOfZWjXMW+x1O9oVdZtAtjR3tdTPXMb
FoeMxiyKxJO0Ni3NYLUg7FKqWoBDXQ1dy00nKJf6kZ/ZRUNGz02X0ChC+Hk1LcRqgjhf7pwvJ9II
5j1p4q3SNJK4kdolfpAaCFGh1MXWhfmdHZmHAAIbrQJRS/+4lT6o/7HN6JBQJL34BNcqoZST+NFp
oi/GG6YdpOsAj9O/YEjP3BKGE3EuULoG3LZ8rr8MaQ3f3YBeyrom5XhocrH3kIEV7iySJhdkk85M
Ee0/he4l3JSlT/jHoapUlOdBy5gixD9XqMGVjVoN6zaiknRXglF+SiTrkljxmQlaizA8zYM0kibi
akthSyPA3HNHIvbOFWuwSPBa/G0gQlH45zNqAfiwaLFBzxsUMD9OMIZxTgqJCfqoAblWC4hpqLRL
Ym+fb8LSbkGkw6qG3Ju+1gMUe5MWHhVNYATUA07JkADmC+P+gid2ZpRFGI9/MJ7o56+sZwdZJcs1
i9fHACBaSrkGVCfUL5z6M6PQzBBheQQUZRHps48rNophP+K9060SxEh2qlHWKdyiFtrwwjE/NxAO
JVL2Im8cJ+HjQJSW1CDXaCAxD8iSRplcO6AVL8gNfzaK7/1EEcuiNzzez2o2Mv7KMObkNZlucsB2
RpMXNQBByhHKvwe9upye//XIocRLp0bw6drSV2VlNiIw3aQMcJgVpSRiC81yU07j6H49ypmJGSZm
URV523TCvI+rNyDeGtRJRSRuVdQO09C4ppNMszGNLnTKMbjUmef8eEQAdDHFvVtL4vey2BkGqRyw
CEJDIZBeopRZ/QCaTSzGxV031srPr6d45oAwRXqY8cgg+P8p8kYcH8oKCzmFeQRtt6DMULTzv593
BHnIhWnKYnWtlcK31egQ3GEc2F0q+rfmCNupiZPpQuvKz24B2SeNl4S2mfQWsFZ319dDtKYW7UyF
vnbAtJFkgTIzPOAlV9fQTXtHraOFTRP3wYWuImd2Dm8LsUCNRoUSqZSPJ6WPxKiq6FZiF7oaPMH/
0Z7mzlKbTVqg2WHrCdiizdc79/lZoSsFS7mUdHg81292OMi5NdBC2/aVfN5qwLNeUoHS5LUgE53f
+tB3JbuoQlK4Xw985siYiESaXECT+7cWmqXpJf4rYoN2H7bCTaypmd2U5fDPbizTsxC9lGFbofe9
er+KcoTIb4IAs1Iz30Jq9FF4E3KDq5CmmXbhgJ47OjzNJACXFQUx93H/OoV+WIBUCUvNMdoi7AWw
Lo0EJOl9Iz4iRjgdNXJ2WwXf+vHfl9NgGWk1YnJ8tOVo/eWJGBHp6kDXgP6DarqVEHzyCgQVL4So
5w6oIRMS40JqRKorlxnBp1JBbh5Ysp4YdgNy4UUZkfQEfFtRN9Ob3f8wKyJpVG6JejDVH2c1o6VS
wA/kdKpFGblQ3EsdvBcKWRdO49mJEeQvzgf/b65CfWSpwIQiz4B8iw+BgLbA1EiawhrTXZJpYnM/
Q/u5lAg7M+jSIYWwh8XkCV89DLMMRrmcIdlMtGujLAV/awIEXyBqE2SZ+/VSfvbkOBwEqBphKq+C
srIt2ZBAsUVTBz5UC7PIieaxSp8gfhnVCD18GuRLQd17U5SP6eClXwqBlcm64j2sdm/MrDDQqUbY
Ftcu86K+FY/DiHyYFbX5zjepFklR1VDipfwNTJeKlB1MBjXADIG8C0f3jL2xUD3BpCs6tn3tXoYD
EE1aQxWAbOrAo4suWL4AmfivV/n8nP8aZtmGv+5hrLdpL/q0vvHnedTtuluUtegTqWpOpljtSctC
YS8OlNTMFLnaMkV4CNVyk5Y8sfjvzwlTJp8kk1LCMqxua4GSnG+oTBn6GCKnwFZ/K3WVgA0Tg0Pf
EKJ9PflzS0zum7eEl3Pp6PZx7qo+05gCTUbb0JQK0TXoQ8aUDRdmde4gG3QRl1DGV9jLlaUDIqym
Y0ecgH5e9ezHAaXDSg5e6bp9yRU4OyFirkWeHJCvuFpApJFBCEg4HDUdxF2/BhpInSa84HCcHQVG
CYaH1Af2++OyQWryS5meqfQIDiJzg0aR2rlEWtCfv96fcytH7x6eVvLu5B5WbnyNc2/CaGUgoRU3
ArB01yh6466ELvzwvwyF6rO1ONY0AP84p6wZm9YS2KRybMuT6bchRU0TPC+woiH+9j8MRqsrMnC4
2NI6CkfLJkQaGoe3p/6y6bqWrpdAxd2+TbPN10Od2ytcNB5AtJh54VfzAsyk6k1G5kZRtOwOHQvz
Rjd784KtWn7K2nCikGws2SFeiLUQc572+hTNnLu8AUBpd4BG9xjH4XtIgmpTdlB9vp7WuZNBrg+s
IrAlSlir509pYYxnOpUzxLRyJ57hxtUxHcLw68MLm/V5bmRLVA4FDx+ZjPXcBtq/pA3g6oVKDbrH
r+4Ksz4gR6fvxDrqL0zszGgmosv0TqDhy4I7+3gOh04RaDVORV0bBP0QZJbwSF8neDtSN9+iz+df
8Dc/nw8S6xJdc/AjZGiuq7sciTrIfaGA0U5Z/blc+BCZIg/3X2/X2VFoccg1JpVByfPjrASh18cZ
aSagbcivqn1Q34DlvNRQ6czaLb4QdRaCA3LOy9//9ZSRrYcaZQKwz/upv5Ukf0FJQPk9qNmg/5Ar
P/3zz9PiCJJkkpGqp8Czmpaip3UUhIQEyIvhrGfyryg3/rFBNYkF4gEVs4RB5/FYu5SygNJEPveE
d4WChG6DcAzJZTV3QF/AThPZswu3+fNuYdc1em8SU+JiruuBVV9Cv+ktgH1p1V0bc+wfxW5Qhn+2
7nArRIO25QbWXTZX1t3MgPiA+UiQxWgLL0uy3/OCLqv1+FIPrE8T0hWJCNwQCZFlWpevLhUyv7XQ
ibAQpWqKnrNCKL2kDf85Pc8ohKa4E0unBCb08fiBCAX2baA1XMPBrewkN9HBGaYhUY59V4LbixsL
3BwkeS4/MpfVxTLZuXkuZoOIHAtCwfHjJ0iJdBa2L4ClOgUeE9VKeK1GWvav7z/PydJgi4eZlxnT
+HEYEW34Tl3SeHDCTNdSht85aOPd13dr8bU/PClkPJdeIUsp3Fr++3GQOsqbum30lw6CcFkId3q0
y0RjU0iyTbsbHBwYXzRruHAmP2UXllFhHZHWVRe1oNUeAh9EqnfUX8buYIXmddZ7cuE7qR678/z0
9QTXQ5E7Fik+0CGHjCv055XxiBCVmC1rghKsj8ENUie+0w1ZfyUgtu6ZmQ9+jNfU/XrQ9Ql5H5QS
PyVNGRdjndqLkRzShmIMbcQ7kjuIAqk3m5N5YZT16/zfKCY+r6IsXfVW940adIAWMFML4TsNYEqE
JRWLhJIDqfwSXuLMYEunEAhpFLzpj7Gy+nVR0KNMWwCIoc9YQ2ne86DxYo6t/48Hn3l9GGp18DXd
9425YiiIiQNshszfoqzyry7bMgqZHxpjkFfDkqzsYtdJIRB8pBkxMtp2oGhMrW02Nv96EijOQofA
TpFtIj/y8X5BPZhjTYel6EdlSRTbhMgrpv9qean8fBhldYsJSBAEGAkeUQP1bUSznsVEev56Jp8P
AOkIdFnpzLFUm4zVroyp0MrBjI5a0fT6L2lEzCGFnbuIShiX+iS9H92/zRIOBoORIqBaQn1p3Z5u
QCBBnXqqWBTRkZDBZxRgahvNdS1k1Q1422LT6l23Q/lVdsYolvdI5KYXbOOnW0yMTMMTCaiUuZA5
VzPOKuTVs9B4siKoABUai86oJ5e8qbODAPBgTanY6OJ6EDRf0BAOnpOpyixPqRTtkNOoztr+0+4t
gBiVQIgSCgPR/GRlK7o0Ha1QHwebTnghYOXS/IZoClxSNQ4vxHirGf03FF4ufVopYdPL8OORV3wj
SnKcW1vPYH43TNDtUkG6ZCTEj+NQz6W4xbKpChvEK7kuLvBHkiCF0t3V/rQ57dzNxrY3V8fNxnU3
R4ffH13+33Ude8ev3OPVZm/v+Zrjkd8eXJe/27kH/s478Eu+erPfn9wdf3vkm/d8qePs+Wmbrc2P
5McvX7Ip+P794+a03/PTbH6c7S1/vdlvnBe+hI9gO8uf8Gt+49m2s3N2jMvX8hNvtyd+/JXr8qNe
+JO9Z3seP/HJPdr7/aO99xy+x/M8x3McZ/kyj+/n5y0/zLnmF0dmwie6X4bf7pzDd++wfKl32Nue
c+O4/JpZ77YFk3f4dBtvd+04m/1xs3xQPtuW77x3XvmpO770cPOw2z0sy8RCLd/tHo+ZvQz74PDH
X5/B98Tl/9/qTzu2LtRkcd2ooJbujpvTy37zyKQ859XZHZyHCyO9J3u+Gmll3NumTuWWs7Fx757e
ToF9sr3nG0e0L4yjLNfmq3FW3kVTNSVEZsZhi5729/fss8N6syW7q6N75TgXqv2rPOLnJVxF5L7U
VjEy6ndH9+WR08I+fb1HAFwuTGm5dn+Fd0CyISIhjXS8u9pcLQd6c3z/h3+fXjbcjRNn9fhy3Lwc
T5XNxTm+vLCX9vWWg7W/3+6326233V7bN5ywg3O14zg/X1+/H8dr27nZsd/cPK6F69xdOTb30zvc
OVdXnL7D7oIJv3gQVr66KtLPMma93Cf3kXvDil061e/u/ldnYGXv0NmBzcgQV5uXU+BxLbnup+XC
s2z3/Gdvb/nVcqsDmxke/uwQ8rT/uLvd7s9g3z1cOiLvFfGvPtD6SWlNJc6WQ3naP542zp/dPrI3
282y6McNNs59OC5mko1hIzwbG+gsv3VPm0f3cX9/dJ8KbNvWfrp62/ADmMppa28fb3uWz8WK3O+3
nDvvwDkvbe/mNbYPD2y168q2e8eBeLHsb94NlmTj2jvXu8MOHY6Lgfn6qL4HyF/Nc+VbJYWAsgQn
FYN9tJ+wub3N537ebuz7/ywz08OIXjnu1YYP4WF3v/4Eyrsf8tVHWDleM7qG07As9RPm/cgqHBe7
dnxwT65ztd9jrXcv3BaMNRafV2LreRXmdbNhzXl6dssr4D6xOZsXd386YbA5N6f7wLZ/cIo27Amv
hHfgFj5htQ/2uy3bb/en/f3vfWD/vl9+6Nvj6SWyH2f7LbD3GDvs0Ome3/7+zWnE5u+cmwdsLP++
2z14D7s/DiZ/92A/8oqMth3YW67qj+ubmx83h533bX/Y/Xq446Vw7ngOHM97cO3Xax6i3d2V+8AV
tb3D4Rqbfdix9C6r+r7MzPwPy83jyoi8Lbsj7/Lxytl5N1z19y/8/sAfL0bhwb26e3riIDq/LuzI
19YLz+2j9aKnUiEYPDG8klf8j7O7Pbo8eVx923EP/z1yzoVzQJ+6L40mnew+Dpv0htEXDMuYLMfx
xP3nqi2jLq93ZXOL7Lflrcdcci/2Nl+IddjcL68yG83G86t7vmFv3+AQbPjV8r37/faGf+8eWDT3
4Ny9OzYs62Z5NblRN9zc/bu7sDscuJDLUd8sZ/C0WcxpaO84Qiw/1nrjYo+vlm10d09HPB13d3L5
nq83YHkd/v9C6O/OH4icdx+TtuRrfOhcFEh75iFM6JDWaDUqNdeKOF/CUa1JFf8NA+hjaYhMFUFb
bTNahj2wJgFCY6/Vu3ispmuUfbsbrQu0bUgdA+b9qCGUAb9+SGhsh3hNF+w1tPQcPO1L8dcqNnr/
ODoIjSUyIk/5qUxs5jKyxsh3QSFN7UZN0qsRialNhPbA8esFfkfrr1cY8oKMPw+kkpTlx6Omqhnt
OCbc6zCuHzvI18iZKtvZT3a0kdhpRf3SRcNLJ9HSUPUfcq17GgEGTiTjqjbZ0yvoUvloMbOrD0R+
xSTPYsmQG9YYbhivqKaYtC0SpdpSfmdo8ieHvAF8doueeZ5skmjO5Ht0eqOfc0SHkAsY8jOLr+u6
IlLOBMaKIPLHBfHrWe6QZO9tAPv0VdCLwoXJVbpVGKcXLvqZ0/1hqJU3UUmTHE7LsQtbXdgnHIhr
coTdBR/s/CgWoRP8giVF8XFCNbIjfp5yh7o5CDeyNQqbUkb/8+uDdHYUst0SyCywIfrqHFl0vkqR
w+UcFXH8gmpNcyP0gn7/9SjnDgcAXK4EZSsgdSvnCBxsUPYZqjdJJMXbPsNdhpsrBV6gBu21WKK0
JXdleVD6uP/270ObMgcCGLf8+aIgfZNLQ4b0g0LN9DhK2vBKryphjxSPdpuh9Iucra7fEpJfYmx8
XloojKTBAZGT48QkfNxAYQBxI9QxmmqmWh3jJC92odVcAsF8XloTYBZbJ5oiefc1jCIUq14Xy2yy
kU24F3XttVfNR3/WDz2qeujotztDrS84l4vr+PGuUyiWUXOi+i1DnFq5ljDBB6oh+YQyCGJST1ZJ
s5ZdKSmR7iD7X4boaDcB2Bhk0+PvX2/nx5d9eVlMaUErkBjC7gPa+rioYJpDy0oY2tShySmjH3tF
GVYe/Sehnbb1pYLQuamq4FTgSwGmJZ3xcbxJmn01kNEobAbkqOQxi3+kQeBvYL/FiE8Y5Y7+EJd6
Mn+2ZQtKC+Q4yAxOzhrEENL/GeEaNK8RmRScRCwEN1Eba1Oieep+vZ5nh6KUgkgH+tK82B/nh3ju
TA9thP9Qcx5kHhAxET3fivJsI8WzpO++Hu7TnaAPMhhXXeXILhDK1YstjGjbmBpcWG1EW02o0Rwt
E5rZfj3Kp0Oy8AcZYkFmaLSpX+7MX8Gr5RNBz+iCIl6cmY2Hbx7nbqqH2i9Y+ib6tP9H2ZntRo4k
XfpVCnXP/kk618FffRGMTfuurswbQspUcd+cO59+PpfU06lQQzGFBDIgRSicvpmbmx07p06t7ddN
fhrHgyYPxzGHisFDZSqAiqNeG1b2krpGty6afDjSuU9D+FocCfIU7wo4oXNwLsTLHOvQVCZBNDf9
CVxyRUCVdnlkXXxuhXQT4EjwZxyp6Ol8HEKY3ofUbWCR8bPW3jTxAMtG6Cy7r0ftcHfhu7Cr2Fes
ctODHf5jK9TIG+hwAkDuw1C/nfwBIcuoP5mFO6wQhZxuh2o+EjH81CQjRjxZFdOpWrrDUHxuuGIS
LeWtSSuN9YSmjB34VaddG7BdXvlepziE527zdUfV9P9qMclVEp6kxuZ1TxOT/NjRfBr7Qc8Q5+y2
yaoPxk21ExfmOj7SzEFgyMFofGzn4MzBW+ydJqedev39sVyjh7b6eXr99HVnXsPEX/VGfOzN5LQx
HAy0Yu7Aea7QV9sYl9DwrdGkC+wNiKjVmVydImm0mv/1dduHOYFPPVQL99e9LbPckkrmVNtbwRhQ
mrj64V64p3/3XD0cSbXhf2lnykv4ukrasW7CXQPt0SNlZqfhkQk7PL0PWzk4XqBLSnNN9WbZotcW
QOYclEF9ZC9/uicdtqL2xC99EYk0rFTN10Wzec6C+xd79/R4d0zN3FDT/tWyODC7lJfls5HQTLOh
GiiAH2r1CAH61RK4D3CqnxxZCWotf9Xcgcn1URHHfNDcGDxDxL/6Ua5O/wruHo80818Mxq9b9zBn
UrRl60LPrnoFQ2lADi9AxzHw1s76afetXT/A5Xhswo6Yi8OydEJ3tR+rNoc1Fzs2WLL517L68XAZ
r67b9RN3glW8So8cLMfm77DkUUCiZuZq/ubgednqO1RKN+02vkxOwlW+61dHBvZj1PyTrTIPrEhm
wWwB6YPqZBwU/LNWsLATnj+2/tVW/WKhHCKpLQ15yBhA2cookVsZQgpUK9mfDpl7rE/H1sqB0fDc
tPVKtdE8+88+3CfoV9Qo0dtlBlXcMRzgQdjx8wAeGI/U00wbQti3Acyv0M5au1t0eYOHZJ2siSrP
GGJ99dexXh6E0z83fGBPxqhA36mhYXFnnraP1WVzKp7Da7LASKHUT/N9eZpciWv7/siKOTa8BwYm
6qbEqdSKEawZOLBYn8MeLy8IV25Qb8pNtPYCL3COGOlPwZYD+2keWJrZLLO8VRsDXNg22Rvr+yIg
sBquaoa32pqro+f4fzMA4LSorVQcBpQ9f7TYbeYVpa6WbLNB/5L9IdY+noMV+GdFgKzyTXuNyshO
7qxz/+TIKP83u/pr2wejDN/fnINbwVdZjxvnMd/G23E7r7Nte2Luj8XM/tuUAvMAS0KtA1jFgwtB
inhIOsu6XUkUeXQDThToQ635pS/lOl1uvu7aoSFQiTPqmEyAkdRegiX9OKpOl5hhnFtLoIlObOGv
ROnCkAm6t/NyxIRbBzaHpii4AX9JZbjnwlv6sancM53JHFAzDeELOqv8sqRMS+RHbOjh6KlWLIBF
3AYUh8lhXMUyZsSYWugoO7hSriACd0/lkLeBPpvFVVoXxQMF5sb13x5FIjhcq3DawaY5av384k1U
UFbJtkY/GxHwegNXPjbV6oobJITyY2tRmbBfTTcd5A5H4Ib6SJui+IN9gEKiXHxXmwO3HEo/gIWs
fYCcF45LaVciu8+NoYOEv3DrcQXgoNVWcFcX13k6h492V3YVVE7DMJw0hWPeAPJt0H2USe2tah0t
y6/H5ZPzDRQOyBIYBFDmvgBS9HFgLITNys51ERY3hgEdOC2PZqwhOgLxemqdkAIWxx6mdIvq/PAk
AYT9iFo/8tYGoK1lm9bCOcY7dOhfqkcSrA9QR9Dvoy358ZE0SDQT3ainANmrDPEHYa4QCCu+gcew
YZStB+90rk2O3WSYjljNz5tNMGlUDRAPJkL/mmH+ZZnArq+NM0W7gey87w2Y2ocOcsgrGNGPFe/8
l5ZUgbMDOpKoAhDrj52MWiVD7JsLdMepA8KVEvR1NaewuQMfevl6kj/va0KYxLxcAgwwAxwiJSNX
n4oKqtHAhZRw08kJ0c0mOnJH/XTJYdrguhBUyoDr4whQPf5l7CKSEyJd+iEItThcTai8r9IiEisW
VHGa9Eu1cfMw35h6al0Assxf7GI2jliwz1uPZwAOrYrIQf8fRtrmZRijqmF3eehrOJuoCrU7K9Mp
1fA7WAlPkJSAVO9vj66yY9Rdg8A2iNR/7Hdhx4Wo8hD6o7aCi3C2sm1RuGL/91uh5kwlC4CCwl/y
sZVoHMhNzekA4R4a63BSovxQzcfQn5/Hz9IFHTGIrCl40sHWy2aRuR143SAZ6/Iit1pjnWjwAI6w
u6+Lfgq3f7dXCkpLoYsq6FJnwsdembPe5ovZodmzJNFpWmnLSYhO3pFLwmeD4pk2TBp0ipTbp1oQ
uFhI6c1eG7haUq51HSbCHOGcve7ZGkBae4S5f2qHk1Br35Hy//Nj+j/RS3X9Zvbbf/4vP/+ooN1U
aP6DH/95kfyQzP1f3f+qP/t/H/v4R/+8Gl5k18uX3y6e6va3bV/+fOqSqjz8mw9fQUvvT7J+6p4+
/LApu6Sbb/oXOd++tH3evTbHM6tP/v+++dvL67fcz/XLH7//qPqyU98W8Vi/v7918vOP302VN/uf
X7///c3Lp4K/eyiT7uXnb3fdU/fSfvq7l6e2++N3zXH+AWkBiHSYhAngUWP5+2/ji3qLWfuHDSgf
0LxQwEpVTFZWsov/+N01/sEqBWEuqA1Q7HRsMPV7w/sHIHebXDc1TSBlgT/+++k+zNh/ZvC3si+u
qwQl2T9+fy0V+s95rloEpgcZksLNY5gOYftwu0nSMZn94hlh1/sbs7ZAbAZ6PSTLo233NQUrGtrN
27KZ29lad+Zkx3DeVqH+HJXSKrWgMqfMBTAOhe0687Wy2Y/I8bQXuV3U0O1W2WTXz3bWpVMFT7iT
pyKIqDkyXtypmvvbPJ7c/Mnz7Dr8IQrROJeRkzS1wBNMWh7Fqm1ZXMWG3iGkGeU2xzRExXZRnBsu
AVd/Q/GtMZ+ZhSjTv7R2qPibX6b0fdB+HaSPTh0xXVXiQpDXoniCUX9FPP5i/BW/bB87sfcSjhUF
NfuusHJrn1tDK11o6OGbVrKidZ78BdEBHu0RO3IQLaJ9Ir+QXlic2cwUD/PRkCyp8FoqL5KfqZGJ
DIb1SthowkG/qTUpzG0jZMRrqh0jFBg1S1vq8nqEB6k1AwPa4FGcdk5coooOCEBI4xLcf8N7X4/R
R+NKVo1CFngcFeIZtQ6W5cdnnOJEQzdZaD8dZEB0cx0tbuQ229yzOqGvStk5zvfMRq7tiEN6MDeq
XbJBKhGkq2zmYbt1P1dupQnvJwdxjibBoNd5+2eMfG4J/3aa9MkVOhAoBaCyilreMUS0ujX8sn1o
nmo1dS4C3sVzP/T3I3tINFSjxU/NzV04t2xo6O0nNpLWnVQLDO6XiQY36oXImrm/y1pdX1DijhNk
1Y6c1J+fBFQHDA2c06oG0To43YA7hjjZuvwJhzFbbgubAKoKW1uOfWttEi+0nO+yZwiQRuHER+ld
R9fV3wxJpdfjkVlRR9uHYbHJ7MI54OGvMDWHxAOdk+jpnJXhDyQ+S1vukC6DCXYDN37rz7vZkxNL
5OsFeBAsYwWqgnl2CRsVLwK/8+MKjBSi36877TlOpFto+wmFSDZEMVUIFFFckloUOCekEsCeTD5s
qOhdJGgV3KGik84BAqCyvPMRE5blugGvYd4qnrj2+evH/HhcK5pHnHDqXvFCsOHUD318yn4MkYho
lukZKiDJItBRV2d+9AmSL6WCLAbtrjazRm2abqzUS1KTgfn6KT4NliortvC3FP2FujIePIbXmCgU
tE71XOYQBWlBivVaRiiF9W62z0RoY/fbqJfZU5HaJRZV1oU07L2npdqQrRrcwlfLD0XvyBPCy35m
TVldHeN/OgipqfFikFSUwKOAjRuFGs9fbC/aU2Xtl4t4bkPT0YpN2rV13l83S5fAMT02c8PDaWgV
814FVh81Ji+DqPxurOvwpPUldIloX6PRclbECBtws4KyC1oRpZWY3zoFSkXwqgt/wiRyMZyN8lRf
/JxvzZIQoMyRbXpwJ8VSKUg8TjzYAABSLNaPHWJlKgWfof7u2pWd2gH3XpulGIYwd8nAgI0b047Y
8Kv1zHuL9/pXc1Ibocdb09gJp9lSkXh8D73WAPy6b8EP4IzAIggdnNq7B8sim7K2COOq/l5LdlGz
EcS9rAvTiMV8Jtp+Zjj8EIl2ZJunGUHkHvlJuAow+KNzGzVLqO1lYaXLIxWHrXPpJY5yECZkM3N/
l/W2mp6qFT5LaB5ce7itZZotj0sOV0620vNcHVoJo88EVaWv5BUEfuny6BUTBU0rYaczL+0CjMJb
13Yr2q3j9mrusilKcDCa1+Z9L4IiA4n5CeUPyNYNnSdPkFBkWrvaLrInrv8leor+II3hzhLV0p1L
mUGPn+eFNItAi8Ji2kcWh+u30kNu/XHQB4NF5nrQDf01NGWFi/L1rjy0moq2FFSLoUA5r8ywH5eG
CGfEs/06/74YRStRr6bQgkDcWKHJeCL6ZsRQfN3ioTUiWGURfVNpZcXoeIhraKXexmMhxm9i6dVi
HBHMxfyZJFg4vJ2hsZ3vIXqCLMLR7DtkRWHlclmnXz/GK9nyr+sOulZutZwVVMAATzwMTSxi6Bv0
AotHKH+KTqCH0NvaCzxGDdYoztrSQO/IrZLroUULbYSW1IYFOfI6k0JPCinHHMghontn8EA6d5OQ
uacAIoYz3HaepidBYy9TdcYionwt1S2qvlAgIyvMZo9hUL+thhjv4gShQWJmQTaAZbgiae3WaGdk
UkzD7useH9o1KtzBeJmq1/SWgNDBaZU5YVyOTes+DLDx4sTaUpo4scOi1i0hLcvax8RqWLZT5gte
ou7Vs0XZWS1pgbi8Gd6FwOp4XhMlm0LuEyizlYlsllY34MREkCXZIeaXsevgUFY+tTF7BbvTNRq2
0dddes2B/TKJHh4QmhCEfaBVhV7xkEWvEWWxVGlpPnhdLNhbXR2pB+g0FNrZuq/7GGQwMLNtCBaU
LY6tVCZF1g0HjRYbuPHGZKtfVQ1KW0+5n7rWPhlzNQ7NPFbOZdhMfAoNOdVFpOyddpuhLiO2NXQV
og2QR6rp7pGuHXiZdE0Rj4LJAyBDmNo6OIW6KTPcvK/mBxENylIBa2JpLTnywj863ctMSIGQvVoe
XbNU52OhVQYTgqwkAaLNUjhGF219ofXjA16qZDhGNxWsPgQcsCZlovksMWvMa2XdeszmPjHrEbPW
4ZHQYNKFOj9xxzIYigKyXOey69wYaXA771O2ROybaCuhU6jGR5nC7AjI4MA6ebgLeFfE0Imm+qBE
Dg4uA1V6dCUb7X4o3Arr8ObemuhHIvzFzTKOymNm4eBSoZqktpUcBMcSYI3Dixfsd3itcILdt73B
CkF3omNBcfYzPgBmrcrehKNWob7u5GJmwHOE63BZMHqM0ghvfHftOq0XpuitWh7GgA05IK1V8amp
0Nj43YRUwOX7tEUNzLnjaoJ8jL3CLlLTEWWTmggthVPTDHykpIdbXSW9kp2dgaF9zByUTI/dOYlP
Y+0/bCdHHQIYCUPpdn26UeEOopytT/N9HM9OHq66HgWFIBz1ML100PqWMygg6RA690EGIgAsZZM0
p3reCyDWNd6OdiajQrMuQqolRQDN3xT90BNEC8ewt5x15pZV/hMcwiJvi4qqwKdxMfLxyhoM6ELX
Xlr6NpoL+I9tvx1H2xsuJRQcUD46hV4YAMil4a/LUqLeiBpDj0Z0NXkNUpVxOUjSEdGUDWyGYZHj
nMNig7wP+iem0Vt3Tt7NCJojlNKP/a72KdYI8d/CqDvpYhfPLHCXfFwWrrUsxfpkymaEiCjrSp3t
gHCJWNuFNi33o1OZyWNv5VG4FlZnot/B/bRCbj7qWn/tJ+aYBRGM5nviZxCcV/q4nKG6oOs7Y3yV
RNFaL9bBvFWF9TDbQ5RpDz7aZ9M9oTqBNFmLPvctJ4bb/7Sl48iHxR0iCKPqqgKgdONPS57twoTo
xnapLA/NBD+rhBkHLlpyjfdsFKlX/ozNuhqmNUtlbl78nhJPcvn52BrpHmGBxvbW3APs3NnBb5E5
l6DAtCzbDU5ttnn8Enul6BjlyRCetC4WUVE9tV0Msj7xDQxPnaNvqE6ta/ek98Mkzs9R784adO4G
NEmG89EOkZXYhjCB9PZtWJqiOXFSK468LWvFgYSiHhadY53K4QRx50izHOjgEWRc0vlkjBDqTXZj
AjVAFWT+aGFghxr5sz8rrXfs9oTFMWphMArcFuOyr/G6/FU3C29yrnLo4njp3n6pJUnOexC+Iq4d
LFVrNc9L3/jmcJo6so7MvQEhL8hf6P+z3t1NqK8WyFpZgzoXdVtL6E4kbA6VpymcyQcEqR37dnQ1
j/VYu9dpqKVjvnUzgRTcSdbPvjdcOSiGJP6q8X3lVbuys+Ps0UWMHLEsy8pbRkpDPd4oLrDaTWyf
aQIRuPwcurPEyK/TdEy9cAMz6NgqIS9ytTLAZKlHAnYO1e9GJ92XNGu9zlLprctO1+zyTxPCMtor
0tz3H/rIa5pAcvVmZE2vTzhBAsOJ1Zfw/Lgsq6bxlU9vQRukLgaxUQoELeNRjZjIu4yXqoV+8a4s
XGXyraGLPBeZ2q5iASwl/sau86WS567fuhp36GbyxSmpSpezpA1pDQ0yLpmlkajpMdBuNe1/Gfmk
xrlU9OvdWkOek6nQkJ2JrZem4ULTbGWS4GkFo2fMMKcnXoy+JDNo9U2P3HQJIxbjpSHauov7xTKm
Cy9FSASkDDNdL3cOK4sWBG81z6E2qQXmSE3NvD1r/C73CzU0w2DwUY5YePt5hqFsaTZ474+UQjTP
BNxifmdPdeXcZbYV+iKwRp8A0Kqm6pOxeF894dL6fKWbaqpzSDy9DkbPqpHBu4/r24utfhKtnV0I
PZHa3ftQa28f//cgv32OSIGZXbhmjeBWYJRaPDxniVMncpeUYqbTjblMtBWZIkr0Oy7gERUC9ttE
VcuAkNaGm3cvo5PSgIFbicfHw+xc+UVPFutuMIucj5g1MTYZEOYIBx95oVk5vVEB9ps96kKk9uy/
jWBVs4Owa299is2EOxqEIaWDQObce+p2rr9N7dvycMIsZ3wcCyJ8fWO7uer85Mwx6zQypGomtmKH
X85Vo7vxw6IlVt+d0lOhhvdtIS393POUdFJ9i5EgoUgFOzk0VldLfS9//jagGnqm/IDyX2W5Gw3+
iyw9WaBGnmo4qQki6Zsx6Sv2tJ9GKvLRwh3znAyu2TwbTlSyfFobj5XOywFn96ollq2+0BzUC1RK
Hi95qavtUKBkyUvZO1E8PvR5lEfJtow8vheFCyMS+6yFrrA7E29rJUlbv3N370PuU7rE40yJyPgS
TgDUG5E8IoWd7AajWRz9Ac8t9YZ13WhdmQR6G4U0bqdxxZWpy2timzkBA0I2TFMMEriK1HbuOV/5
XTb3EAps0Tg1pxm+5Dafqn1nVTqybrlvoei0CtuIsCEc+D2fj7um5QWn0c4v4Tzgf8j5iNvZOtTo
2qohlp9fDlkXEhQYZUrrRhxVw6NThhO3gHBe1NofybcRJJ5Eg9Q22m9x3nubHHFvPjJpaNy3J7Bw
yGX6pjtTir2J8qrKsv17ODnt8lim2x4y+qr+MVstyJF9jTSzo+/E655pKqVaCzX+iNjbo4i9auwe
GjHGo7Pv3ro++VHLECGMvSDt5WfRCIIZ9kEDK9dJSw2fMdVq1RCvUkv8LX7qtTAJIaQEyS397ZLE
5EWywPl8kxB91FZJvhBXhl0GtbkVIQvIXC9EDQCiXDuzoe6wg923rKu3IMtiKLlK0lMNBDAnUdgs
fMfyFnpD8gV1wH1jWxkhSrSauPoWBXenMuhgn+QeWmSO2k+dNSYE4aPM6zCVwglnzrx2xtKkW+56
avD6RKhQgdl7IFav07yM+HOJZt5Uf4PjbAq10zFspUwufZGqIGXVc9xduFkonO7GIow1hxsqKbQ5
3jpjbeftmtAFLBIrlyCQ892KgNMg9cVZzeQvmrXQK6cs1LFRIGLKqEkTpWdz/TaSaVcRiRbwFYvh
dFzsInRvsqUftTuJM01UYakb3/mOvWV9aYjnMQIpJRhqGdUlII0t10sVpcoT/FU8a7+oxvq7A39P
YzxbU+7kl47T1HO4tcyq7bS/RsqKpnDDiSZye9XmxL818taGKx+JSFL6d69HTRqhJGTPIp5uRxff
pvmJcDGii9/a0CM0sZNZPxR+oJlLmz0uVm9a1arndJi47BtGhU9J5trvjZ5VXiDkGAz8UgOpjoId
/uf6vSdvc9nUKQFi2ErErLr1am7yfFD2z58jZU3w/tXmTVr0hotN+Rq9D1NT/Q6SH41PzNGsPhgK
ohPFhpu7ym0keVizlSO8RQTMu9moNykbVe1Kv1DvvC9ZfEoskQ+6jLfeQvDKnCLOJicQPO7KMKXu
XfexG43QnuolAXtrXkIfQeGmVLs8gqKT0W/JE/Fi4ZZ1J82is76RpWOCiVuqJ88SMo3f3xuypc+R
1rBUtLu3G1uZpIuboTle99ZN9mawkBdX39xQ1MRq0PJGBSFb6UjLWqNL3KAMFjdOr931iV3T524k
izeconGp3LjYmmjDHXL1WP3rhoOYkHNkFdq92uS1qdKM63Kc1Jp0w8VE79SO27IoNlQDshu3bwNC
HFgZvcyjAA/z3sIWdhabAt3DI4Gvgws9sRzsAytYMVlDv3IYVqZOEOc0q827uKocntqNoondMFaY
2Uaz1A7KBwIv8CoBv+PZvw4oqDjqL3c71TzgGIqnfJtiIjbux0gfNLOVNrYuoao305iqylLGn4RK
fqQM8yAvxG5CBgC2F6iEBf876lr/SwB99DI0W3El/71G9GyqENyrQ8u6QgtBrW6kKNWk9knKDFeW
tJiyd+P4dbc/hhDsV74eCqnoPOlw1rn58VnCQZiEb9Pozier5nxPbEP5423ruWKzVLjOx8b5c4Og
1QgcIOwFLY19yF6ZxVI38kIPb5up5KCIMk78E3fOMHPvO/vrDh7ghFQPid2CEEWriRJH6zCQOeUp
0gtd7ty+W4wxXlTQfnbEbNvbyYKZCVhZuMibfhRzCuykVPZcSEwDAA2L8+jIE31c6TyRUsSCjFvx
ucFreJgWm31dG91ZNLf526Ya8evY41Ofhdh1SqQSpiC2+pmdCThGnYiNFqsHAf4G8xbCmtzstzY4
IBv5WkzLHGDqGz7O/giNy2QW3CeD8S2fVb+Z2a87cTiNTBxAGsCNNiFZ0HwHoSfO3aYDlzpcxm2m
LNPy6gjVrV32N7Pm9dbf4iympJH27NdSUZ1a7k+Mie6EN0LlUH/5fuxNUYzmtl5hWcEvtkn0t0Jr
sEBCjuy9Vo1SrQ0f1IE5ECPauOWQpJdvxxJOspoNN8vZF2XbqAPj6wH9aH+IzyLbwkJVoBQFGj2M
Z47zMiVysbO9W2oyswNXgbq+O5INc2wLfm6KqQM27XiQlJFXPuhbEZrF3EdOtH9zRZDgVEnNyWwK
Xr7u1TsU4z+G1SZWSFM+AJnXxDwFbB8tjK6Tl3GTuN3JxdRjlBHtSaERemq6++qvdkFKwAHLFhFb
9VG3h7LHWXV21BnFGac1EBwlOF8T+Tk3LWIP+nUR2lFU7Wd8A7u6DKcEqaQZ/UNSTt/apim4BsnU
tMpmU+Q9aK9Ar3Qoh9eetAm1nYvJQDjw2n/L52WQD2viCuo8A5nSLIoHH8hMP1A5S0wkBaqx56Lh
JsU619KaqXh3UFwqwFkD2ZtbgYfucVg4r2bs7aqRjTqme4wLE9PN1VC5ASMSpTi0FTJT+WVp9nwA
F8vp3Uuq7ZQzp735NojEEleBSdUzFlTI2w61eZiMpY80iFO7edqv/h3yaDg2Uc5+c2RePSgyayPj
u6AciJFwm4HIEneLzDE3tVfRZJFxqxhOdbIVSRTkU9FynyKen6f5g8Dt9cWlM3e+VZ+kjq6pYEA7
SOKs89s9zB/nVjSIx/ZUjN8SgXHJMkBi0XkQU6JYGo16sWqoxrbNa7/xa3fcRA2bu7m3Z39Yqnvy
DSqjhQ8Ig+Jl1bUkEe6TmmhztAaEBJxgG8vGMNKgMHA6/5q5erbeqQ0nm/kdqXF06C4Jm4X1Ten7
aWZu0rLV0N2uMRxTB5Q2Jpe+KauZuV2Pk7lQcKFrRCaGANfMsL1gtuZwPM/8tmvRsc3TMeE27XuS
vGgS6+3O0lHzfEbzKpvjdWjhcKNP5ZaF/LMk8qIh7/6Wcnu3RQ358Mg59wrsdrot49wxe7zoVz+L
wLfyE+eyU4fO29Kgqh5vsHTzjCub9EHE1CsUvp3CwJJFFQR+k5kh3j1m2uDfY8Qr764ufS3fFokd
2egPROOdPSd2uob2Mdwl1iD2iS6Wk0JOw55IRnXrSge6P9+O0TTucp2Y8SDvQxb13ops6hbYffEz
isr5n5GeVOvJN0Luornodlx2CSmZpY3Grv69ytiO5Vg7586Y1GvXigG3Nromt6k7WZu0SvqrJc07
fYNX3m28WQfAn7VO8SOu+zsgmPWZtLTorBjabmO3hKDBvkT7oer9deyP3o1LZTp5/Tr5mbRNuM7j
OlpBXlyu7dBvTr3FLLZzWJIFLmsblsPMm8sA6VN3O/KVJx73sWc5Vf0OaeLwZ+Nn+S6bjHxZzX5q
b1EEqO5q2BMXYMF6Q0GkqKKHcVq8JzRMbK7yfXE/emay0c1OP7V0P0biWtPEuUWYbiu7tnxpUze8
IXiYgFdCf/ynQaqH+4xRG7eDmcYJgkcltZ1t0d22YPxPlClYtzOEraKVc7ayi9ELQtcPY+/PZDD9
+QQEQv+jNa3U2FR9DZ1slBTIuA7C9l68znYLVIg1eVr4wBHWltGlN9MgKGghV39mt53RBKEXV096
2tbnk2vpZ61jqBUaIlbKHWQYTyfc2QvdzYYTot/aaZKJ2Fx7WL+fxjgKqE8Xj7qODlzht7FuxpdG
06bATIzlqW3TygRRUAMfRDyElRtTgbYCMSX7db2M2XTq9FETrUDMJ5ez4WKIuVIFwyhycWp5el6f
Ilwqt2bdm2d2XkwrIr2P9jj/0ClgvoTbu18NbU/Zt9voqFVMxeCu7bkSG8vtyss6tuS3uZ7wyXTS
21GL/jEYiCxwk8hGiqkX1hOZ6WolzLzcVQQKVibadDeTUWY3bTx3WZB1XfTQxHPzp5zqwlw1Uz8F
oSHrFJYJPSfj6hFzY+NN8aJUuMdr32zjPIDTOn1Kixo5iUgvHssKCfu6HowbnyTCSW1KJCakHp5a
KBE/tZ4znVP8LxHNJuBKo2G3Cnut4UbaR+eOp1XJKjcy/0lqXAbWHv5ZurLTtrl2RidDpKRxnMBH
PGTfGVV8DU4HbMcYywezKuvd0E/GLq0H50mK8GHknvywNMXi7ZragiyjKaKXmQHZxZ3b9xvcwPmu
k76N8qjVkLHNIni4Y2o6HD+rdw1+qLGK3NZ/8MvOfxZTLe5TGVbPwzIsLz0LfD24lXlhASzY6ZwU
6wbt2Tv8S21lj+Vwrsk2+442RbkTuRGCzCKcfBnPusVZNmGR9DTxiAfZmbOnpDwM6rZMd5ndywew
XYLnH8xTQy/FNnVE+424XHPtl7HcG3Pu3xWFXM6iNm02k4vJ5RpcJJelpXensrfG67IN5b2EMuGH
yAaMg9nMw6U1F2weYlpXhuj6s0m640kyTgIKaKTjdqFTWGuuxyAsCXv4J4smw/MwjOXNYnrxg0fo
5FuzeN09B360Z7O5F4uhdWCYnGSbw41wTobbEEFX+PnaW+ZSsN5luV0irbrOCMFfR1NVU/hf5/pW
jmnzre56K+JyvSzn0ke6EKBSRnSgqO4jsSC/gzrAtBFu5u0Ncn7BUC/WlTdEgsi81H5qoQkG7Xy2
LWh/KNWZ8HXXbk9I2zvPbDG43UavqOruVrlfh+ejVkfXRFnyS82ay8e8k0/8TUSgNzEe2wIPJu3d
9HLyU+CXdm0kp35Vm997LezHALoc/QKoT/+QmMPQ7GKEo6mZiw33zAor6W19vSj90yL26jV5XGtZ
DeS7156/FO4qXTpoYgoRlpeVRr7/bNYal7F29LGT540/kOgxJmmMJ6XVFFdisrQbt/STOnAmGVeb
2K/lbRolQ7Eh5TvHZ0WSVclak6UNCDEMDW3nDm273M5eKft4p1wPfe03U5VXGaNWjVF2mnEnl3lg
uHgugV304XBBtCRFZaw3ovvRXao5qPTcOQeuFxrr0cBFPOu4iHePdsLtT2JHZN3ZDo5TVAIr2g+d
457a5qSX6f0i5tAcVvPU6H5/amLs9BPPIiOwa/KZirt4aO3+zteiLAWBE+U+AuBosudZoFn+dJcI
UDMrM7byG+SjtGU3ctFMA91tTP189JGyC0xJHP/CzTGn1OA0y7oisnWaml0SOIabnXbaPLXpVT5r
jr9QxqnKHIs1cZoiUyit2rSLq66zUq9bz07q5CYB9rZiP3ikN4Me6qViYxl9Hp9nMdnZVVES5g2W
bkJBTxQziR+3T7N9mVh2tYlIFF7AyyGcdTol015E8EGsHU+PoS1wUmmcZJGsSUf2tjuvzJHst9OZ
3SUCupMbFGlotSskcgShOGJ2j0atyZ+Dj2siYEQ3d1UVGmITDbHZmwEuHEpFAbl5oGgUo8XO7axZ
lYtj1ntzkgdY0o4PVLqWTMkPjFDjOZu4zuuVHTXG5P9f5s6rOW4c+9ufiFvM4ZbdbCpbshxk37DG
iZkEA5g+/f/pma0dCTuy3uXVWzVXtgeNRuMAB+f8QgSVz/CySJhL6zi3BjYO8iPN3Dq5KDrf/iOd
pq/blqUfsX75mgbCQVyhm+vHGWxHlPhJH+tcHvBR8cql/eVt19VqVne9lcvTlPXBQXRiE6EHTFPA
snTqxx5ez7HvXbSDfFTCwn4a6+9jmmwnr61o46VLckuH0dcPxjLM3XHjsrHvgyGzHj0ARP0xn6j1
sB/YMCF4uPmH0YryQXTN4EeD56U3Q9u0j7IbxjSSSzoll1SNUftA9T24rNuiO5pNV53KLnEem1I3
omDM2usycbRbs1zsa1PQtGzTgeZ1wLPoaJrJ9EcjPRlvi2lWIdZZVX3Ug6kbImG47R34wXm8FP2M
/PUw68uhK9PigCnLJMLAqBPYAwAi5eXg8uWilSL345b0+Y+EvncXF/TXjj1BOaOfXvZ33PJc/rlb
Vse8IL9gCsl7bp38JLEqPshGZJ+KPDW+UnlbToB2grjVg/rkCa+41wq9P0y1mz3pTf2xKkCCpTzc
Tp6ZFF/a2YSa6Fht+8XSk/5KmlayhEm/FP4hpzh6hecPXzrVqXDnCxQsNOfeFTxLrqbZyL+XmeV9
LZPUeCoNa76Z6NweHdG1lxYl408U383yfKYtIrQKvbtFSd0ib+VwPG9C+7tdnh/Da1Ofb+3FHL61
k6/lUeXmNEIpJrfuZeM0eXsY+nwZ6TVtmNR33gxPyqo4R0JXywvnthKD+S3LsrEMzYo5hEXlZf6h
ZNwD5S/2RLYK57J2JRqAYwaQsyfXKtOrWrTjZ8GrLTuUAmrwVy7euQ8DzZ+nC20s3eMoCu0i7xzz
4xk3cDK2qZRhjnrdO8dZim9y8gXXAy/PUysT0FBt4lg3tO76a7ECKgn7lJTmZhmk+FaasMaRpepJ
bPOpWr6PmA33MUHJO00Kqpg/JrpWU0hHboqaYrKuKFKnQKbyZSOZBzb6E4HwKTnVXjZe2yvvtxAN
/GQ8VkmnOZHW1WB+UTd0Po1DVX3xxLQcysEajpWudfqdnD3jke6aH4AKIocL3XHOqngmqbri9Gvm
aOmyDIvnBSX/EBSH1t5Z2YwJm0zOSLy11h0R9WKCYQAihU10sPFzKexyOqWTSyulLg9FSZLWR+dn
LKTBtctNcmqrSbanZpBN+c5sjXk48qpISo60wG03cegNmVZrrOlm0djvXGklflgaXW79UQEb1eCX
a/5SJCcaZuWi35ZZ67bBgdf2YgtE6bJ6kAePC9dZjxn9K78KJWhuez3iCJPU5fXqJ6alHwbJA0zc
VxPVIStcgHkH8tRL0eVPaVramIHOhAptFNg4VgOXeOladzyl5GrNpcykVv9CYHmZnCgD/1Q3kdPR
a3tMdJPeSywASo3NsV9tTS/uCylKfgdbAy4lC5DM9AAmYO58/Z9ovXk66zgUzXoMRLY4Tw5dpuzx
r2KtJs4Nh7EKzqVR00gWcR0gzkdfALzAuVtBHG7ej9RO9MWNwVVjsXPZGUOQf5FizrQsbHwKXRov
26SYXa4IjuPxk8woKPg3IwnlcqfjLrTaB5kOsivjje4WvxZXXtEW3yxfNlN9dKpRrs21Jfl6Wwh7
zDRh9DmDVSeP1uiI3I1cgKq5daVL2a1oOlr5SI7D2yHtTkL4BeexNrbHEhTSrQmYi9RdBJyYa5CT
RPl2nI9eva6CKuxEJRWJILKRarajtFnsvIrEDOImoHbQtP7NRurnR4lWuSgrjlMSCBkadhfYkbdu
+J/T96s/CV9WHzXQNWOIQKHuh7YkdiLQJvUPvSnJskC/Z30Zte4QZMcJaVBvCTezo/m4uXL9E2V/
FeTpdE+xdLqgDpzftHpiHUrTlbeFsa51JKwasNYU0AgWWvVYBMvsXXakcF5oNWK1w6XBrjnuRx0U
4+ILLEmBUJc/xKYnJUerjSWCyz0qj6O1re+HXJsXEgStishAeSEmhXCcuHdhsh+T2l++aVuyrLjY
pHNnvPfLvHSOc94033s4/304FBNPg2bTJl4jfWFkEelEP1zIzCmnH6m2nCsuZNRmc9gwJz7B05oS
7VRLwwecY3ZBc0h0u20jG97mhTG03pcKE0kDYmVipu2BgmLu8EL11uGuxghHHqEJy/EJ6AOwCTCs
oOwOYDq6iQTJMMEVUdy6S3l516HdkYffLjTclnCGhRp5pVtdaSleiwPAa8gVYOuQDOwO5iqHo48X
NS0pjKFjeAv8MN6SaqEFtu6iE9gQHiQFs28bgAX2RhI8SE1v+Z6bOLkwy+9XfuyjHSR+EBVgK35q
gJcoHhYivdE4hoevPC7n7MEr6v6cdVlmfkEG4171SEXm3zgirTW2Jrt4385WcgtMMv2R9gYr78/b
AlwtkVRGti1fQpHr80d/ceT93FcZXwEaG91hr245Tb0askLpBO8NyofeMSja+dKgaJEfZ7Axn2fL
hkfolIN90dhFATyxdx67JMVBwmz0J7cfjDDwwCFmfbWB0B/w5oJytN7BqTTzoymHCVIXdj/IXeVT
MF2mbg86bWg24KBpAhPan4PqDI3gNXwQDdqsJzpE9Fnh5+fDMZ2siaNXg++QhyPi6hJByqEjKWjW
4daSQt6kpjH5R91JhXcCCCE+zIs3gjoeG74laADvq40JdRrWJODvOu2c8Q7Y5zYhOTX+PG6ZBMBR
yi4/6y/6BcgryiX3W00FINxcIdyonADYHS29zqOtW/h/Ugc4HbCRWhwnS/yah6yJzGRYDvPorF88
TovpehmbXhyrbvLfDw60Wz7OQRcO9yOqQLXZ3lpVYl77WVV6wISSFWkGIwmuNS0zv61VXl4tmhju
weoVBzBg5h+wYmRDn8EL1kPuDEV/8GY7X49yXoshrHp/TCKZ5X7F+dtb1XVhmKuDz8fsfNKSTCx3
VK5KPInsFtHLStTGlzwA8RDWADHuWhAmeuTNzsqjIDBhNXSJ7tRRbRTZh9JZ+vnAvUlWR35+zPC7
9M/r5r7DcIsytIX/0J1f1dZTB8oiDSdZfbGGun3qzwZMWd5QewRRCVAqRZgpqPovqTbrKbnVoh00
Mo/bs0f9YaDu8rVJpXaJTd5UHfu89N6NcmyvRqeD69F75Q11Ae9CS3T/ExXj3GMbpO43YW5WtNj6
8H7qV/OyHNrRPBSTP5+zNb0GOtNQ4vGGwb8YrKxxj1ugkTjVebDEjWNO1XvYsvmxp7h17Nnq9qGz
HBmRvhjXzdpmYANn4ylL1uUpSEYjFIPUoU46ZVT7VfILWLF+REti/OiT7seGnRjfWhDoTzr/ixNq
CwsH5P8Jzo1/u9Dkj8U0EnW+/AOA8ngvpL4moT+2ukEcbPdBqpVkNIZdx9wH+H9Lf7COqFRcU0XT
bubO7D8XFDuO/sJDpYNTvIVLZrSfNL+yHzHctdGEoqp/KURj0AoDaVla1vdVUv3vo1JQD+q/cUGV
9XSkBw6L6YkXbVuL9709tLbzbiyyjlN+8P0zNqnv4D8DEljWou7oNdBwbN/ZK1CaNZ5NuBrm0Wr1
ZcwudZnVxXYJkHsdPyb5MjvfncZuy4ui9evRPiR2r4/a0Z8ce+45vErQLPS0wEcUgZG7+hHgnbGR
Nvr6mh/60u315VKuC1XM0DUX52Tbzex/dZtm5FDpRFmhFz17TqY7R/I8cApHbXXTFECLDcYKODJp
PKiqFS40QQOM3cZVecpE+1PvtNUbjjQ0AepFg5jXMqNjmaclaCGRJmcQOXuwow2SogGidw+T5Y88
YXJrcfv+U+vPyVQcacT6vPugDOVLcVcgPSbb4zC7iClGurDk0H2T5TYZa8goIl8Pc2uTkoWbyDgZ
LhJokkVwoGJ9/ia2m+pBFWfpMnndZ6mlm+mEeeKX/B1YeM9drrVx4MF8XaxDUrmHBTFtbzq90Z4z
aL793Zyj+QeBOoArS5MTmB7Ah5fNuUbnzVEsIviuF7BI/t31Nt3Sof3UW3UK2nP2p6Y+6LXdm17o
9RVEpLCijzIcRqtZvI/Fn42u38/rZXeZaXn06aGr4tdF85Be0ctp5c4KNSnNvR9lK87cpvov4Edd
BhUbUWtpl73RqHzZkz9/IjRuVuPMHUagW5Xmpmjojzp8iZ8ol5w/cfoLVWM5DU4sPNQzWwKCm/RF
g/KRFzQr//op/iflhg9tzX+qBMMLEYf/N3GH+Gd7FkMY1KH+P1RzgH37bG+c1SJeqDlcNj9yWvd/
CUOc1R/+/Pd/qTgE3r9Q4z1LNfypvuBY7O6/RBxc/19YiBp4DsNA9uk88zf/FnGwnH85OhZ+1D04
00Hg8Fc0kc86Du6/UKvhD9lyaB0gjGv+LzoOL7vsPH9szz67O57RP8/QPYGZTy5IUi8C0k6ys23r
+jlD6eoNENFrwyuhUcBCWOel8SLe2H3/fga0mX5Il6399WyZ7/86A54rLJwj/++T4e/pnwPl+fTr
rfTPQJQI36phexBGHYB8tQo6CEgZ0U6xLYhqf23+F6olzz/stS9znsSzDztLKBRz2rjRMoCgC33d
SnucAVz/6++/zMvo/vvLnM+ZZ+N7QaeLIljdSAKqvzWM2aYWqBe6e7P6Y7PEmrchJ0WWL97//gNf
+0LnP3/2gcLXxUTS5kZTRaZ81WYSoR7IOlke/f4DXmLI/v5GZ4rSsw/woYTro7ScaC4Hb75yVysx
D6IczOzGKbPCvDVkKctDN3QNZGCd11J30pts6i9+//kKrOrvCZgvJyAoupfOsDqRTNOJNM/0Y88y
fonS6uh4dAgH1aFcPe2GUr1RRtJsW9JvLfXN+g1I0GtrTAA/X4KzvtOE+B5LgAzPwerbX54z5298
v9cGV0igLZE6++voROQ83pPervjQT7J49/vVe2V01Yit8ovcHazeiUorz3/qqPjcNFpeviX29drw
ytkAgJEKZ+Y4UTV60ydj7njxJ5u37+RRFe37ai6EMDsnGtFN2tBH0KaeFLFt/zdTgP9sLV85Degk
Gv5aFZwGlGCLw+q6iw0Dh1A67lt+5TgwixW++SC0GHCI594POdSdT/UIOHrf+Off5VlwDuDT9Hlx
/HiDuBStqa3hsgFd4S1y9sv06O8FUoI/aEu7kuaKyafmb/Vp7g0xRRUKcjno+8wODr//Gq99jBLi
lt0m/iw0Lx5HaY4Xjds2Zy4ThKRI5OO87As1Vdi8a6cusZbajxHX2D6U/Zq9I+8NPuz7EkogA1Tw
DequQWxqC3V7dIGsm9SGQvOZMmz5luTXKxHnKZc9pQZR+p7w476y10ut3vR3AaSdt7LT14ZXAzrJ
QR2WmxtL2ofYxhSL/cXdWvHGZfLa8MpdL2n6e4gFuvFU8QuMVUrfUGqYlP/+J3hteCWeoVw0a7UW
fmwPU8lvsPqLFg4897adH6DEM8pWDvw8Vp++VddcCsOhU9AX3jbf7/sG52/2LKA9c7UAvFPLpqGX
f/L8Ybhf8hTTid8Pf16If8i1PCWewc/NTiFTL4aB3iXveR5D3LO6LdDpAWeB97CmQBUvf/9hr/0a
SlR7EBoCHZx0LGDl5hfjZi1BmAFg1PfFs2oTvORrR2e49+ISMKd9OdTm5IeFtPu37ubzrv+n5VJC
euVZrdfwPuMuWQXStymA9nuaDJN7lY50U6IlNdfmqap966ts0rl5Y+Vey3lUA6BqSVG62EDatZUP
vinThsQjsy9Bi0X+OBf2iDJQsU2HPHNFfSppinmUG2arfZxgAst9C6wiadfE1Ty/1JK49jRJT2P2
Yt+j2PX7/aHI4fzndnGV0wBG5JJ3VN1jbMj6NtqMZAKyl2BkfCEo0q7vUsp8v4Rmz/WFvVERv1uQ
J2hu0dPwiydIdI7zxlRe2aqqg7bfFA5Ij9yOqQEPFmKNwU+xLHP3xv322vDKsVH1lmusS+HFvSbm
GKQxuMLU8tMfv1/I14Y///mzQwNdBNcv4JDFqVj8Lw5X6d1w5vbtG105MzoLrRvo2EHsVLxkQHvA
xYQn0q//m7nD39tAOSeGHIEXc+n9eFxnKHm+3ff6t0UYRFxmZnqLthTApNCkXJ5+F/VG8WzfN1Py
emSlKjZR78aun9QyFAhi1eEqUc/bua2U82Ozt7ID+OFFsnOMyF2n9Lgh1nLcNX3VJchNAtBD3bLF
g0zHGFh7EUKfL944g17ZVI6SCVC8yvDw7La4MHPEsUajOGLtbe7bVKqENK+e1seVYotN3o0gB43P
TWq/lbW+NnUlDTBc0cBHTLc49dbxls6tTi7QZeC79y28Es5ZIUdh9esWo2UXXJrTUh4Tix7uvtGV
aLbE5IixZPQxAVUwWx5G3chg7py7Es24IW4+BWDmPqJPUVpyotfi2fs2vKOEcgFMW4fVusWdkVen
gRbQgXL8dvr9ypzX9x+uY0eJ1yZxsm0ztDmeNecnz06wFvYIuzYe5zdt7l/bO0rIgnycmqJM5hha
e/8+GNsiMmgy7HuOqwaRI5Iy9owcZ0wjxL2kGg1wcqXB8vv1eWXuKqPHGGukr7ZCxulQ2dc5DO9b
sVQ7p65c1lzUSQmwaYy7tkiMAyANuuLZUmbHfZNXghZ1EnhdG2Ue0eTLVTliQQh8u9oXVKoOM/VR
bTJkMYJxgXn+aM26X71zeh9E5r7pK1FbGpCW08lcSAnhy5XC+bIGa/PGxn/th1WC1ik0XDz9ZIo6
dDtCRPjAmAfBWw4ir42uBK2F7xrwN39i5bUvPeBc5BGXZOfPqsQscvq9pg3uv6cOZAeXOTCUO1dd
jVb6YwhcGFMUzBSNzfPow+6FsZS3dqlPIqkGRl+KIDtA5Jch2lHFvrlbygULvdJvdVNndNv82eV2
dUrzdGdly1KitUR/xM9TBg82WccVDSZeXu6yLzf4L4braHlJtZZT5IwJUlnGZIYG0hf7rihLuV7r
TJgN/EAZNQijhXOWQxjYjJ2rrsTpsPWjaLNZRjXk9BCW2BdtGsydgytxqidOb60AvSKYJs1xWPI/
BrkNOwc3X2b53RAsBZmwjAo3yEIX7Gsozx3SXefXuUn1/A3hWYWWokDH1IH53w60R+4TL63e8FB4
5YixlDhdUBZobEaO4a/ABdsgPDtHbdSQrN81fdXZxQSnWUuRTvFq18AVNUs4sQDP+33f8EqsGnli
9u1Sc7MmQ3UFy8E4DhB09yXDqLm/WHuo1cJCHUQi3GR9NQrzAYWVh30TV27VBRUpYIXaGOeZdsfx
+IU+985a4Z+Cns+enUGeg41vvDEu5gztssz50JZJu/MHVeK0KQetD3wpYy2HpYCt9g2kzLfIwq9s
R1OJU9q3swAPpEVNtfzIV+MzBIc33HhfG1qJUgSuUjTutDVmWKCXG0QvN4S/mu47elUTuil1ZFba
/RifcbBP9sg5EA75ZuzLNEwlUGVXmXqVwG6s2x6ayOJ9y3LxlkroK2ujOj0lft55U97L2Fn79VDX
gqmXb3VeXxtcCdGgQc9KaPUYY60Q3PpDatwiISw+74ojQwlREwIKtNic7ZiBo7Tq+cnz830/qQqJ
2QD2Fgk0grh3pjNXcPlSdf79vnkrd6k9I14M/Jx5F8MHBB5uHXt4w/X+tQU///mz8G/nBKVGTPwi
PdEA2hXJTb6hgrdv3kqEGgY6hptmahE6be/q1fviI52072j502rh2cTxAp44zVmTKmseWsCmoHZ3
Tlu5RW2QXtZCAT9C5u2in0EAO/tuUNW4RqzO6LaCt51bpzdoWsdNn+xrs6pm5Xk1LpmUTFrUH7dJ
Hgrv064fURUDRrkX0b+SH9HOSjjTwYO/ufvOKV2JR9lN5bLO7hivQ2F82NbRjAsJu2PfxJVbE4oG
ug95MMaDBpQAo8GLIAme9o2tRGRZ5QPSMboWOTnZraa7fyALu/NiU8Vy2dhdB09kjLPcXULY79oR
D6n/zez6P4VaXQlKfwCUbzuTFnXuY98efarY+9ZEuTQzpFVs+NNjLH3AHLM1gPDv3A/7Bldicqbf
ta5NMkRGJi7mit4+Nl7jzp2i3Je9lHqpVQzuV849gPHvub2+ZRd3Pkj/u9yF2c/LAxYo2ap3fjBE
fY1tJ2Mvcto7tnJbGnOOLsxiUDYGqXkj/bS46uzF3bUq6Ba/nHk22BNieZKN4mxuuOnFR3zedyVY
4Opejr0EULSB9o7xYq0jNFck3OEgkgHlu44WUH0vP0DMtZ3Qqxnj1BZ/aPP0mebDxz1b0QjOv/Sz
mweyld67FusiZeocO4kCGqLZ3q48As+Ml6P32eRRj16Y+LLcy1a/WqZuX4Qaqv1QgVik7SG4Hvul
dVsBOIzQgTV3rrgSoRJmiRvIaYx1UT3Y6D4XfbYrSUGzXFkTjE3WFJpDjEONeZgxFj3guv1r18+p
gqtWOgoD0PMBNIP7JR2Wq9xzHvcNrcTngjx86ZtaH6+ocYPPRp+rqYt9MAzEtF6uSovEQjCBFYpp
IW3HZmvvPGt4C2PwyrGlgqok7KIS2wIMf8DaVOEge+1am/T1/b6VUcJz1ixORVvyi07rD6gxD8vg
f9s3tBKeIxcPHKh2iEs3fb8IcYku67596CuxOYGzd4vK7uNt6rIIE0fzqFXN933zVq7PfLMREl3K
IQ4ycSjtFW7aW2nneVX/4Q5SIVOzRj14El4fZzUqqmHvucVthxx/OBemXA/75q8EqVM2S1O2WERV
ufW1yuzPmig/7BpahUstIB4r14NabJrTcDEhTR4ak72vVYen8Ms4Ss3MyXvLZOK28Rn7oSa0NfFp
38yVGM0WGCg98mWxY+b2HG2WhE7Z+FVWHvd9gPty8ii/p770K7bkoj3ktfkh7/a9xXG5ejk0clNo
9Y0MnazBw6jn7xLL3dWGMlSbUDxdkrqbVgg+SW3Gmm+OD5BB811IX0PFR5neBNU1ZycmOlTDte9i
FPT2odOgKL5clRrJ33EZsj7G+QnTr8k7oW6+rzpsqFgoJJSlPJPfYo7H62k1rytn2RlDSngGc4rW
SZf2sZekTeht63XQ5/v6ZtzzLxclYJfoiI/1sdFO95bR3UDi2jdvFb3U53Qn3Fnr4sH1P+dG/1CV
3a5HnKEil5LFrstUFH3ssjIhEgEz1jS1v+88VNFIo1V0WtEGHX0bpMp6s4TdG+xLQV0lNBFHzNbG
0bs4za0aPRkKFZHUNXfnwtgvf86iCEClFStxgxT/wZeu+x696G3nL6reooXjwgK3uhhBeYwtB/uO
m3Rf99xQHdSl1vits7Rslxa9zJKzdi2RI/MxKttVw0Hz9+XigAXWg3RpWHvE6b1DQ/EsThL0s6Jd
J7qrBOpaSvQz6kTEvjaUHQppov4lAw8y6q7xVcCRUWOLOgeaiPtsRbcidQtItpmz7xWgAo48FFd9
HevOWCJniAo8IHaL1+/OuSvXKXK8BlV4hM4G20OrzEB++o9yXZDv2Lc2ym2KlKrbz5Cq4zYrWqya
6o9LZey781Tj8cps51pDnCvuG19crIM+nOaqzS72zVwJWSjw1iqqWcQFYmKf9TZJL2zPR4Bp3/BK
zFqckw422CIOmqQbTp5EPTl0ktZ9y1XxPM9/SFFVzBHNOPT5xcTKW8N82ff+x6yr9tXmDRVy5JU1
snljL2LPHh/zdHhAtv5x38Io0Zpiw2JVVdrFyJV9bdrZwHXDfgtb+8qiqEAjzAM8ZENrEVvYVXxF
e3i5kDCy920ZFWiEs82C0IjTxkRqELpAX0IN0f19x5ithGq/avToK0Z3plUiuy+uyuYtFJN3Xt1/
2C1/ul8+K8F0CMY4wjfbeHJL9IToFhccNl6+YBGFD2h5UYt1fpT1gNviYGmY6WRZ53yA4uZ19xCq
hx7h8tq9KOlLthdFiUJ/6FU5xfh06fyzSJVddP1HaPSaPOhrh8lYm2WoNLokluYRNdlMRp6QizxW
BlWyg0uXGh56p/lFbHpLZl8mbTGvB0OnmvCkgexdT4ZVDN7R8hbGnKt83E5pF2RoqlbmJk+1aSKR
MUzYsX5FndNO7kfb1Ypvg+F0XYygaTDFyLS65VGMmxMV+oQibeOZRnlw0SSWF6nRpgEKkg28MHxp
zUfTR7RiMt3+UuRDv8V6G/gr+qfVZCMUg54r8iyzTQkbwQ/7kKL30JLPBmhH+H2Oukbd5r1xPTdJ
gRG9ZYx2vLHaM+JHCIRum1bflRVv6xgEaIHEX9In2yMu5K23LwtR0V71Yku3lFYbu07WUvXRQjO1
gn0HmkrctuxkJZGsRJy59c/ERvTIy3fOWzkrJzoxS2Uyb0cm8RBUV4lj7CsO2ubL3MOZQKZgQyZi
+MOImmlBGQaV0e5cEyWz6fXUckuadnFqFgWKL90vhPz2JX2qS2YBvXVqPL2NMRwSd7DB8ovWGut9
R5mK8cpwqZaN6Q5x2pf2jU3+CvJfjl92nfEqxquv0QecxNTGpZ/KT6jQbBTzIf7vW3YV5dU1qEa1
W9DGyAojnGoWN9mW7mOaGSrICxssw7F90cZri67RsdXnIkaiMt/5ylFhXkaD+q9msSNdTK2WyBzQ
eEXwyCm7477FP9+Nz476se7mRMvGNqZR9WsW9pWjoVa5b2wlUoWc+6lbPXzOUHC2w3HwlupgBYX5
a9/4SrhOTrfhh2uKuOqCzQ89lGfpseM+vw+LYah4r1k0laEvKQmCbtihREcwyvN8Z4Kg4r2QYE+K
DdlvqhGoTYMocw8CUZ541+KoYK9ZhyrtoPsDq7aqrlxrckZUxHp3H74f5duXGwctuhQgU8sxjKzl
VdYghsibdt1XClbRXt5Sd1uN9mVMKWu5ROxdxp4+evs2vam8Q/DJkUF+vp2KvE4PKAalCADW9b4D
R4V8Gb2B2ijv5FhDofhnBtr851bLeh/y0zCViHVMqymyAgFpx/Um7bIMGuOgJ/PsvNE7fIVXZ6jA
L7itSeLi7BpviC33H0SZTy1S6Y0pjvPQah8gnN1pWlAVR7K4MjikAY/RU4a2Vrvz11cCG1IwsnEF
+ee8duhyashUogeRNaLa94xWAWIuqvy8Wc4nE2JSCXLHKbyztVtHfd/Rp0LENl0i5DSZKHOjoVbi
RV/MdliUNiaFu8JbhYm5Ay4HKCw28SpNYMub/Ax6//u+sZXQrsYaowm5NTHOGsNhSa1f2+jsnbjy
cEm7zRiG0qvjSbdPyL1emeawrwSgYsRqTdPTGQWReLSn4VBqNq2GeXu/b1GUmuCYVX1qzBMq5rL3
kXkzkbNz8p1XpaEE9eyhl4mTRRPn/aJ9Q+zM+t5rXDf75q5cxENhN63dGHVMrnXnTegrd+kbWi7n
Cf7DU1HFiaHA19noCTbxsJjZlYEIXpjm7bzvEvuTFPssO5lLF9+l0qpjq/TbFKMAv7vKPNlk+8JU
BYyhDN5aLvp0sec0KCsG/kVpoxS2a9VVyFgvmhTjy7yJAzubbwa05w7eWEwPvx/9vO/+YeFV3Fgw
lyuKytzv1WZ3pPy4bAZRpRsIcyKI2zb7ciwVQ+avLj6KVtrGurRGEWbOiKJ7qelBu+8u1pW7uNby
oZuCnL3pmI9y1N+nGFz/fole2Zu6ErIoWYy+ju0KlF/HOeY9pfxNova8b3QlZBs2o1aCCowMr0/e
T0g8PzaZs4/NZKgwsipvDIR0h+p8BvsPoraceMxxv943d/Nl8iaoLuhJ3VQ0w6lKtJ3/oNlpvnNh
lHeuRPZzlejGgxBAwukA+bD7slVBO+0cX6kJIkiTJPizVPHWe9+oHd0ib/15z7roKprMxgKLHV5X
kFbbBGHrQU4/Mdrd19xEGvDlsuc835osOS+78BMKjoOPxjgyl/smr9ysrVlItCqZfJJmlJ0MEyHa
ctl3QyFL+HLugbt5qzNQfzPm0UApOwePcCgaZMd3FV8wfHz5Af6EdxSZbRUbmbse/VTX71v4fO/3
LY4SrauLqbY2d9oxNTAJuSp0Q78zTeHIN2b/54v8v89jzARfTt+1LXNxXcnWcSVOEDhlNfIiLydM
d3iISfPkYDA8HDsHO+MbbeVVcIPYfld/MTGgO0nMkC49W0OsNNgSibrCiq/9uxp7evNQdx1inFua
Jdu3NllxRWjEWcNXOsXy3cLL6noSxXi15tl0sjATYQg0MLDRqHN7+5AZ8FseyrNOxYcm9wUWudJD
2VqvkZTNdJCfd4XItO3Ivx7yW8tM2mlXIqmrgDhwjZ15JiRHqHkWd1NQBjcmVqj7Llg9UA6aViud
1tanMsYi5CfmpA+Bkd7v2y7KGcNbc601dy5jawNnW5n2pdkObwlpnEPmH7aKConDYK5Ot2EpsQ1C
q+OyH7ZqPgYrqIfjzAshxR/IrbJd1TVdFe00OnytbMwEY01obmSXWMFsoko/7lonFSSXrYnkjWiV
8dTaGQZZ2+cRydI3Dvpz5P/TOilHjqGnuSx7WcZuJfNHUNWY8yDN+sdSGNoblc3XPkI5dPQk8FJT
dGU0LBbuDXiJ910eTj3FdpyLYLS98ah+7SdXjh/gCamc3Aor+Hwsy5N0FoSGCyTcc+yjzAOI7n1V
JUQ4X55DaUbtJOkrFq0xNYBu7mcOop0XmG++HBy7PoNCQFPGBu240ZpPo2W8cUC/9ksowexZYDk3
OLjHMu288TKoBufUon68Rm46VfoudIHuK3GNX42HV4inIdOBkCBc9/Qp6Lx91FZdBdINa9Dl+doX
sec54wnMtR/iKLzvsaKrQLoppxRpSSPDWdD/P87OZElSXNvaT4SZkBCgKeAe4R5tZkRGNhMsWxoh
EGoQ8PT/imP2D8pv1al7fZpmRRG4mt2svb7kqJcN8EzRXZXHgZLx11+WpDoehmyoq3jpzgAYFMmU
XvfNL6G0GyMD7MDx6H1PDsAHgpdIr8oPYR7717fe4LrWWSHrSnb0LuPR3ZxeV8WDCfFfHw1ZIT5S
2tWV7sN87q11NxFnL1cdm5cSuppnIFcBSVXJuAEACH7gICMOyfG6p1/sUiKkqTlgTTdZZ/UdVK+f
5wbE+esefrFPmzRrooV6sEnBaDp64cZbMg/XSVEB5P7rVwdiC/0UZbqbrgdjSbf5fZQZe7jq1S9l
dCusyL1lk6icApvoSGn4pI2U1xUVgdL+67u3k3DzkIwCFJkZvdvppjfTdZf4pZRua9e1UQ0CKTBW
OmAzRlLuA/+Xk/d9Rf/NNXuppFugzt8x4YdNZJepgGqs1Ckcha/75hc7dIdJD/gTusPUkgKhsNEA
MtVmBKXluudfbFOhgDvMAM/AoNW0U7BSa3M3rRLUsuuef3Gd+nSsx2xmolIBFv/yA1QA//Lm/6nt
/d13p39dL0m6YxRjbNqbeIvYckc6xTFg1MA49BVOSdNNx985c0AFK35IUV0L5ewkX2DHqdPtOHtB
5sOu44Z+VxkQCjd1zrrsqgo8uVThrRFALICvvqdLxjWnjpHcHwAVt/836vX/H5MjlzK8setcCtpp
VgFAmOKA2no/li2w5uznVT/cpQ7POOn3pdb+4KdWgxKRhEqL5KpKM7mU4SFk4wxYH3+I332/Ap8x
qZ1kV+mr4f3413WhsyWxtcPDFw/v5sEmczENIKFc910uguqk9ZiG96M/0D7WJZNxX6Ai8eO6h1/s
9kkC3k5Y7Q4LBZA4jyIMcIEKct3Vwy/2egOtKUki8IwnKGuKSZrmEeB393bdu1/s9CRozeJ0dodI
oOuRyL05dBu/8sNc7PXOhBhAwcEd4FFJn0e1SoCs9+y6MOhSgLfzNszOL/YwjulQwrkajjBJfZ3r
CeEXd/IggJ1iObeHLlvNEfg4+ItH8roeO7kU4bFA2T5IZw8svHOhMveK8er1usV+qcHzYNHX8Lez
hy0DJEcSCWSPvDJWuZTgcenTiM346ruCXUtw2x9i2utmCcmlBC/atZrrgflDg+mZSoS2LXEeX9e8
J5farx1jEHUHfDxEdvSHVexFtfS68er/wewA4E9Nk078oSOGFKum9QEEWfkv9/H7SfI3l2ZysUvB
bp6pnFh+TOuBL8+tVx1Q5CkdzDExGrfgVYfBpRKsXlidxD3+CE7zqFoob8px9dcpwUhyEUPrts6c
S/H0phm7KocMrBTT9uu6V7/YrrLHcQA9I5BnqwZyB6jMyqr6uovvUgkmNADQinNzANZyOYJGTAGk
Eft1N9+lEmxTwM/sJpiDa3cQi638tMc9v+4nvdSBgfqY7BNqPQedt0DkDmtfQpJ6neyfXArBQE3L
XJbX+hCpyJT9rgH11dt1zk3kUgZWJ8lg4j7Vh87NbblzNZQ5bPKrq1YMu7hXgSZGydk0+bHvx/11
J3p968n4b77170/5mx3LLnZszUKIPcTKB25izKO8Bxyaxv9WI/ynp19crEkco1y9CXFMIpTOl+jn
NIyv132Wi10qY7A0wc/IjvD5qodi2aFOdO1qv1z3+It9Gg8Tm3ZixJFrNUKA269pe5/Gw5hft1cv
FWDa5h5RvBZHAUJgL+h5IFdGYpfiLxhxzW6jeLRKcP296yHG6wSJ5FL5BRhEV7fZLI77u/WRDPE7
NDYP1wUEl8qvngyt27cpqeDCdQs64DNJr3MTJJeyL8RNCJPUO3Ud8od+jO6Tsftw1VL5H5Iv2Ai1
ho1JBaioim8SoLf1qQ3Kf7ru+RdbdNTx3A9+yo7JFK+wUE9scn4f1fs3P8H3zOVvjgB6sUm7SOoE
tLb0qHRkAcZcFvVoMwJMHOZUs/rUqD20D26v/xfJ9X/C07/7n15sX2As63Hp5wFp6xrGtYyHbqD6
ICV23XBs61UCFD4p4GoKYCpxt6/9ZsbsNA0a+NcjEuteKjDV5LKdQBGM6u+MBcjuRgJJqwSfettD
KBDk6PlepnGuH8AoDnF6WqMkmyV4yEMTdQVhomNgCbpMIxCaUvx0BailU/NdmxZQ1SKRWadODKxV
OlUbEvqsqbZ5CaaUG+vXF1jIhaUruATiBzbfW7fasYiFj9KkEBus4eVtrMHYbAuFmqVTBeYKBo8X
tNk0ftJUIZHpsz7/o7TCPxs/JwtI8gksTD2+kCyXJdAOlF0PrB5iZGbH7xOKtpkvVhOTOBQ8T5v2
K8D0UvxUjQfoB4Oc+2RUAbevfvvyLtK71bsCgXWEaZQtQ+hsLKsMg5P1AeD3lR4iWq+2rHOsNFEu
adi4quiyc3IX50sqjh33u8Jc2Dxtt6AEjGWW6iV96InvQBbtWGBlm6XAc6+5yqtcwQC3WOcmnUfo
N/upbSonkO9nJSokazPhzebRZEVO0wxzI0t3UycZwkacJanyZ/xaE2imJkdkB7x6BBa7VyP9NjuV
VmAhr9lP3+0bO2ozcfm4G5qnb+1Ms+yRuZqx+71uc99Uw44ZleQogo/hiLCnmR8eMKGR4/fSXQec
fNmQXTT+SOBqjGhMkWmXt1vK1vBjzlU3NeW0oBh8yjCBJF7jNYMZYTmMCUhiTR6920AOfhhDhCmW
HaItOOhkfvGHDb/lNJ0oRyGNnlI55uDWplIcU9mO5ZSuQRlUU7bILu+R5WLviLfyEAzOqMd0anz/
uq60GXMsh4n6Y8840KlT0yYULrHtNlTIa9r8aw6Y4HQn1h2JX8uJX00RtEMxvxA5zygiKOcYYyWI
gaz/EMvcpEcYrMj1bqQhRlWbOHir7Wgzu6XB7BbZbOqg5AQ6+YEM/gcdIszMmCVL9EvGVZxXbW15
/wO5Tz5g06hkWirb88k+Sk+a9BXyrFkd+y3DmJCYyMTPO4+ovI/bIPdf3ThMPqkSE03J44xN2x5A
ugePFKzVfv7cRionFMebbFJeZCoR+pE4J+MfSV/X+VbUjVDNTQjLws/EdMn0BTzsjZfwvCeYRm8C
iwWsnXk6/KxdaIAIlbPMf3CWzvozpsv3tkR3CXcX5jym7QGqPpvjP56i5OfUm2U/Kaq37VXuJI5L
3WIn/ewTLPPbRtL90QnSHAmd8/4pNz5LDyTvdPtxlu26PwcMeNAInWj4BuTVuxNxerLBjeMfic5N
e9en7zTiaeqH+mamIjZ3fhYZGKwJS+jXPKWJ+BUD8P2IEfLojDbS/hOjLQpkUt5UDQyComrt9jyc
wZBY9luYB7Evg+gSUekBk44fsq0dxse4qbv4FKYO6Otobvv1VmyGACqerpJ8Jmkt64/tLBpwhDcX
wROxJ8JiiEaldjkvOyi8D5bsjpyYTvXwCeCOenryXGTtkbRyyiq39gvOzsBz0x6hn47NwyyW9OcA
TwBwp1EyDE/tSgyOknZawyHlkzNNBR51utzJHgbHx7rxGuM1QKw3r21uRXJSGgjhwtWRSX+0reh1
2YxWur7Ix7gmAB0lbD3ZQVlXuUBJVDk70rgYhz3or8wJvEHFSRPDznDFW3TgUZuiXyMLGPC7JU8B
Q7tdPgLY2iYHrk34RskWUuDVmhG+nEBBpA8Il5rfNbZwVvZDS1WZqsCnzxswtxwGR0rB8qxg77To
U3CYkn3dwKczddHOLltx3u86AOQLuDJA1QUq3ov9KWPnmo9Lu4s7cDgMbgUJyxrxccCj3n9N7bw5
cJGi3XkYA1W8wADoyG8GEQt5WJaGDYCixi7f7wLg9ihdrGBZiVtSbwgUMc7WticL1FpU7KbropeU
S0OrNgFtvrJkiUUFkvrevxmys/52cXsQN15NUV3NgdbbPQMx5xlE0r57QfmIbrLohsGJI6zjG3cW
EmnM44a6WH5MZIdLD8DsdzqzAu76XjWkl+W0m9iViTZAfAPbYOsuYIRut/FHR6TCRMaYOPfcrSSj
txP6xv3jBLu7bi6WLQFFB+biBWjZIj7FTFj3xO0cjd9pt+bDfTowi4U2tmpof7Eh37EcFHzb7GFq
8m454i9b+wNXMrGfUrm09dk2Xc9OmKRNhwcPenyMWMKTIa0AZ2L17x1+yTA2t23Pb+3UNQ0EzhjD
wkLJYaZ0bnu36VvdKwbhMIWQmAB5C/RhsbhtpC9jJPLzogbxllOJgi9s0nn9msTtEP2B1P7lXfR6
CysVuh3dZrIXyD/XP5OdSajiCBdgufSj/KMxXPOmMIbBb1Mcz3GxiFlut3EYP0uT9BXskLuPyGrg
kbSTCEDCwewqK8VKsfQVAbDhcdHrUmqLYO1ZUrQNj42LaBV6gMTh6vkhzcYlPAw73ZKq63rLX5SY
8+jYTpEu23WiBWgSBMtAhaEknu/2m+kp0rK8h5FK6ZALPvQOc5/PQLfGUQWZU30X8A8PezM0VYfY
CbUFKtla9YnZvkhjGlcqjLZt97AEZN9bY9Yi6dOHVklyWqyN2A3mbDU7zVBg3YosT172WMEMphXY
9a8kxl4sBI0WrIeBl5Ti3iei78YKp46dH/fI54clB9Xek/pe95H6BM/e5SnzOOIrDqR21c3Tz520
c7GpuvsGtkp/n4QNbuegjlt5C0jyliDicOu0VcRw5j7PcYPxUQRaO4d9oYPjILz6JNZBMYUoeaVg
xdCqCzoef+YLw3kfYXbvTvcWkvUeouHmTjC3Ln+gr3FdIdBl3SsS0YXf5Znb11/ZqMKxWRyky0UL
g/6nfHZpW85r1OoP7YDD8BubVF0YG2nWlkpuHo4qdZMMUyFNppvzTmNnKmiOnL8JNlUPQSEY/DO6
7Jm5HWTrsY8bhU/VYqR+ENFcP1Ot6/UIYeQ4foRmzfUvME9I71vS1cuNmrdte8zg3qArs6Ixf0pg
lbMUytNAC7bOc/vFj6Yh37qWLU89o/OzNmYHdx4W7HZBE2Jf059T3M3xiwOQMfrC0AqLPicpTlLY
NjnHMUWbDCnfyqwzCy0bDQLtue12U86zz1DvTr2vy2znyzF3vu9vkJzs+iFAE/MscNlmpliCgtSq
4Y9UqLHcMhATTQ1ZHs5vX0S9ryE/bn1JwTg/rKnoTkCcl3UYvyrgy4ps7cIpQEfXT+NnqPG2cmNT
UoJqL1OYmwTgEswkAMTmGOjK+5rApM1vVTMkGpG91eAOLiK+70Zw76vWtOSWB+hvtxpN0WRM3SHG
3G85DGYuOsZhHGHS8ROi3m9APz/5GGCG2GGLJtu7ElvRFfFn+qXpxMPCRDnNMXZGHJObVg7LWO59
j+5RRJKXWIX5hD6TNEXcD+xGJlqUHiOuz5YM+Tnqs9GUpJkekWe45YYOGU8X/GZEzY+6nVuMr8ew
gj1q0Q/TA1M6RLgr4LBwJ9KGVf00u/XI4y5ZnuKRGBg6o3EvXpN8DO1xGYBeep5py77kFtigyiY1
akt5F7n0cRt1nR2J6QN9QkOTjR+tS/cnngxDfKOHaYrWwr6XL8YEJy4mLqCBzG+WWCM32cdG3NU4
MvVa5knSPG9QVkXlmmL3frR7mDFwj7lqGkrYZNayzAA410/SooaJj9cM84FtmNsejhiBjA95zcax
MqSmuoy7dogfEg9CODzk7XtwnUO62zalyBdOK+VnEns8BDPjo3LZoc8HWHMVu8Jo7KvGBCV7a2w6
3ZvRI6wv26aPyriH9SCWbr4uRRZSHBLUw1vjtkmDRlCZrQS5YOPQyYVPgAlgLLEEWPYOL0M++Akb
swQLfK7k1vrxRq64T75yYsJypJkcYjBwDMz14qRjebVlQ/tTLLwpLIv3o8/9+mUc65Yi5eF1bx89
1Ho48QxC+u7MOh3Q+6+3p3x7B+/uZmd3IM9LcshBTloRviHUrcyeMP4WhiVqTjIduXv1Qx0vH0fj
4xK9uZl+24Y6LCVfu6jSsv0kVu+LRUe/QXbPywmdnsKsfXvbOg1jlwRz/Qj2WLnvTugiQ0I+Q/Yr
X5wh9JZKGm7WyYtDUBm7k0yIzwMCqnLd+h8NjKyfYpS0ntuYpg0wBe6Fh+U8TbgZznlotl+x7uO3
eeR5e0u7FuMFe2938TBH1DyTAP9h2N/zBziH+iJPN7ioeLLfIGyZ3xqUnMzzEmkIzN2alT6C5KKO
+Fuej7bYpvwBbUh4DIC5y0xhSXOHI245bSann3C6NwdJ+1QWSq0O2hvATigPUdkEECAqia2D7+MD
zoy6u+181hywMAAMS5vtvKf5rzxv3IeEJsk5JRILjg2m7Ej6YeBGfYr3YX3KU91/aIi2EFL5Qcq5
WEkngi0a5G/bcQN8cbtNF9q8pfGqz67fclH145yWavf7ehxNz88bBLnJpxDl2UszBAbQAHVjFt3W
KlvCUNTYKzmMH7aW/OpcvblPnKfpViydWnOIk+MlbFX37nBxGrZ1hxFQbuJNgxU9zxarbO3Y1FdN
usTReYkT+AtgUDqQs2njWjzaaLXuuMC5grzt6UDTUmzJ4u58onnzDbmYmgHNoBG91Z3ukvt+XQbg
i5txwdEaa5O/MT9o8jQzz/QBxiPbCJMNm7anKVrE8DXCzgSEjW8d7ypi+9YVnndIroTzWVeaAVF3
KGoWMTYUG99893PNOZvvl3Va9h/ArAUE+K3LOW7vARuZ66LHCFx/gC9UTW9MPnT9hzVGNeswjQlT
R5fh4KuQozfZaX4XlB7mTFH2hDGxnt9BEc7iKhYrF6cYg4Drnw63qHry1uWalJtolvZsZ8tIWsAi
J0f8t/d02D6g2JNR1HUgQt7vrB0sTqJ2zBBDaYWt/yJRfglfJZfilExo+jKrQvY1tkxG3xQkAyj8
rBMHQxRtlbbE6kDkX9R+kSDAGL9Wi2pM/jmFS4V7y0NL8i/WzoL2Fc/mCMFKPfJoeUnD3q9NEVGa
MUQ5tVGlqNlAH+2er9ufBAYWwy/TYT7zkPcAcX7chnYVsNDgk3kGtZzL9TAu8Cu+EV1Ep+cU+xNn
MGHmPUAAHilD+bsdMah/2zPShlsmW0lUlexmNVMxpGnaAGwwIaNG+tLP5YYgFYE14h4XPvQOIWK4
EbKR5m2w0bQcpz5y4mSt8By/2C6CqWY6rMs3KTim69JWCvvNBTkvR90QFZVC+vium5s6LWdIO9z9
1vdJg58k6zDeatE3Ko1eZmRYcwqDpDe/JyLHyP9c308NnW9CveYfZ0Y3ZwvH910/bcMwFAa02wJj
jo1nIObl/XTcQo7wpQEg2J92ZlFyaIXPCusC4ufCeRfshywOWftnAawnP+ySkLZKA+y8pqKxoKbc
7qniPzagH7u+YFMk6jMA40malHbY+wjJ1Uaim3XHCr7JKI+zs8PN0n8Xe9dW2wjjk6eJWnPoonn3
UAlEdXRCssZcSVAZx6mYu7kuYRjGPrHFQVG5hLbRJ9G+X0/4Wi6GX/E0dSXuQK3eOJpS5Ni37egq
HfEuHJYVozkoY0SYGN2zNu4e8z4QlIC6TT5issGfhrpLR+zI2p8ngtLdg6CNoyfE28O3vG+n8DjK
YM9uzsahrfJtW0vOcXCguNjU32DkgmSkUThNu97IB+eIwHAEnHXCacjyttT7BtIO5pnIbZcZNjzM
jtnhwdTe3nmtp/47NWsuD1MuzSvKKOygIoYoDO+T5qdtzxJTDmsS3jjsdX4bmhJStDCU6bCIEegU
Q8jUkYGj7ssZuepU5mjVL4A95iv6FTg3LcJRs5aDRw2khG2UWEvMcG1NEbdYvPMm6VBqSL8gOodj
Dn2YxOhQMHTRLtQ5Cwtvv6xhmff7PcFl9wnGNRO9V2nnO1s6tujubsohDIMp4LpWJO0nDxh68kQB
5ayWKVt7OCHUgE+PCCqyD3HLUI6pLfL8IgXM8bz3dbRCMDsPeyXRREeUUDuMxf2sR8BmTlSihFjU
cJvIf08OZTVcZUhcAJtcCTQUu8Px9hDlYnIvaLdRcx9gZIC4NwCC+ph4+EuVeW50eFLohv5IdmS2
38aGu/ZzOzWYlpNO6wFCQJW8KiqQ3YA/jCRAApKCGhBgkDj7Fv257VD1QI3ZHqX1W1zgjFjrrthR
i+aVzNK2He62kKFwUmDALP5mrB5ZOaG0sjxtutnDB6LnKPsS6nn0T37pRHfOW4GU5qB8LbvT0rRr
3OK8pfyPDIhpv8mtCWo57ELDJltO8/4JnQMF9duCEpNaixVXvLldexuws+n8RlnLjmjyxHdwV8BF
knN4nBdjSH32CfshDAfRuhZJSx6P633I/Si/BoVqTIEc1icPcUTT8bfuhZCVnGpDXyO6q+VxI3m/
PNYTEG8fcpRU6X8KSf5RW8bGP3y0Irtd42YgZZLAKfseF1mDy7pZOQ1VnWZrrktAsqD7LfcY6peX
BbZG5JzCooncYWFl8uxTlmgw+8g6PgiNAmuRahZgdK5b85tw1rWPdK9HCIpqIsdbOM5H9BkDj1k6
lcA37QGNm3HTR4AXgzlCoqZViXYI9z/GoGwEsuHu8lM0oATyhQxqRgKRInKsYiN0j9wF8ax69Cj8
yRKDEc76AiYqMb0jKeWI2rmLxtsOAonlR6CbsPir0trdhKbLQ2W41vIwMJbPFQVKxsliNmprjwik
BmQECXzToJoc3rlewJxNVd92Yj3XDor6EgMejeAVLBSIhSF6rdCIRg9zas7psrIdR7PTyS3OyQlt
9hlXWIECaiwLTHrufTWr0Q/HZPXx/DvruBwihEhx4hhAtXAf+aOlGjCIJdHacrZcFK7DpIwGI25S
qum2nmScs/zNGyBY7t/X3Krxh3dJn5R9vLLpiWfdsH6O8NeIqGiR7E3++G5Djfh+yfclefTvqcld
HU1yxR0Doete9FvdNE+bii1iMuNZShb0lFBnyko0SXhwBbFKjD+7DUc2RHlbpshv45ZoPnq40iIu
xDZH7g/MzGTOVkw+f+JtvzS4EfN+/yVbtBG+9X2Y5DFpkjFCHjxrNgKinJruQ4KoBlcDFVnCjxpH
+/y71QkPeeHg7b49hizx+WuMmloHbgsK9+6HgA+rfNORn6LnqUGn5sMi+tnCamDLB1pmywxDYsy7
aTOcWoWGFRZJotnRZIjv0gMAiH6+w+hew0O5o/kzKdirmazLKsJTl98FjRbQPYKIPL2XPknsyzj0
0pyzhoXpFHkQ1b8xQpCep+OaYhpnUpEvhoyG6H4isJX6EHnruy/RDqBgKRAAjIfNq9w8dtZhQkVx
ki2v+wAtYpkTi+5Mx4YR3jCmidzPPLW6fmWoDZV0BJigX/ZztIO7bSoGQ8LhFHTDtgJhRr+XcbY6
f7tNo2C3BuXxcDPIdCdvces4P3cSLbxSE4XO/QGDwMQgtxtRoUfd3q48Os6GUl+yVPVRgT33kGr7
XooaOXwtjiSGJno+dlGMRk06ojezFQPYaHmxzavmlWkznty61Yv9VidrREZ4sdHgRSFZA8gZkq+4
v+exsfaNW9ih/86axKt7gqJ2dhx468VLCOipVEOD8h7GCqEke+7GcUjv6mYY5UvI8WHuNppLeyYe
LBwUKiAtB4p82/lz7zPVnNfeCPkJ8SyqSKgYpls3o6KQK5SaE5irdaT02Mw6KmHakW66QgMvy8VR
Qsf37j2cfYX1ILFxKQScK9VBoYdj/SlTweDDuqzX5nk1+GhodmIlgEZOM7G9MHx2TEUJ3sr9E9oe
KGwt2MlHse/ZPXKFNLqjUY0KYpES2M7R9/5bTm9In6b6RvbZzO/3YcLIdEy3yX0NnRco3UkPz4+j
A2F6a4s4oAaL5iSFWorMNl/gbmeU/aaWJKfPE/wSLD2+e7TGSN1WDip7bnax9KVQIchqU+YdBeds
+shNnYynBCO44XYetWdVs2x6vKcWBjPFWksSn5Jdc3Yf2TiOjmgruq4a8kYgrtaz1aiMMdWx72sG
8PtdvTf9+hEF5cShUt7WZv/FRs6aH1pOZDgRhunEE+nCNj9g0N+41wEu0u2naeTJeh8nkd3+bDPv
9X23eJUdds9z1D4E2tMFenQe7ZDOWujzZpc8eKJsKN0G1ufJ4BX6yu+UyhJy9hRt7iR5V8Qu+VFA
jPw4LID5fiJBNvbBuD0ezxlIdYgIUPGuMZ4g3AaYu82S/geKJhEqTzyPtEV1ECFYaUesc3VAH0mi
0IAj9D2PCe+RiIjMwsotimKDbZLPBhMOmr9/O6GRpjcFirbiyWbLEMEhoMu6X/79ZvyVedTZMP7N
m9M8CQQhBCfd8MKMoc6XSYPKvSn8kMCDITCgnTKUQknFKI8giGHNXD/SNnPhiPMT7oXLMHbLb9ev
er2f9kzxz4gC0mQt+rn35w21yPVznim9POG6btitRZxSKNjTzAXwPc1ajQy1eVy2aDk+IyoW2dm2
mA14RFdDYUQdwIIdqfsskZVzoCYT7r57H815gVEgGlDO1BIFCzO3HyFsiJtqWYBR/thDi4gLEVQM
uC2KJa/FW6Yxa6vLkaADhQpXbebJFR0m9JJiytH5ZyW61cb/RqLcoByGhJS478jG9i4qUgftQ19w
HK9uL5phwnxGAVt5HZrjioFO4HzGNUnbr5iJRlG68AHYmflGIdfo+jLMcPwOZyTCK48rw1qIL6rr
NC4Xcqt0S0Y1jXY4EPGlT17T5TpR+qURDx/Yslrk5gfWfcyR83T8ytGT+GKeaILLoai7LDviliJI
VcVCHiwOy39Dyv+D0RO55LUh4aYOSi7E3RE2wdxOnbtTIZrgHWihakE5bOlhp5+JmT6vFgWiEhjc
iJSoyiLn+O8/y/vYwd+odC49e5oVNbYuMtlxAgV0qDoMgzxAdDeXCJfQsUO3Lf+XCf1/ECHFF7MJ
ZrabTRhLjxikn7MXt021r3SDMBNT18jEUAFvowFB4bqN/zJd/A/ixEtXnx66KhzmlB/THCwLB7uW
w4yK1r/8Qf/09AvVlgYJz2at4FBcqB/SxG8h13X533+Wf3r2hWILUfKsdFPzI9pciNfNdur8wK58
+IUyy8WxGyef8iMqXQcIHlFejVHfuO7NL/Z5vaKHwUWXHhsSWVypS428G5fvVU+/9PShUjOoavBd
kKnB09YJ0Bn36eW/P/wfVuilpU9q0KjRa4/l0maC/rJjp0JJ0o2Cx5NTpQv9/zg7jyXJkSzL/kpJ
7lENomAtXbUAYNzN3c15xAbiLAAFVXDy9XMsuqa7M2VkZGSkahPp3Eyh+vS+c+8boJj3mINs9f81
1g5LK4/l/whYSr1kcsk6sbeMEbVfRdN2t5mBOvN//4N+P1v/h6f7r+E+brZYzrgkYlt6forO5VfL
hITL/74Xo3deBIUv/6USRuXspMqeslU+Gaw0ex93cki5KiTphqmGX/NopcoMepeK6D9/u3/7nP89
+a7v//P36P75H/z7s1ZLK5O0/8s///lUl/z/P65f81+f8+ev+Ofuu759L7+7v37Sn76G7/uvnxu9
9+9/+seGsrhfLsN3uzx8d0PR//7+/IbXz/x//eDfvn9/l6dFff/jj0803f763UjUqv7414cOX//4
44q1/tv//Pb/+tj19//HH7jFuGy9//ULvt+7/h9/aLb7d2GTb+sbhmA6qnmlwafv3x9y/L87gjkO
rmc7Qtj0zv74W8Wk0JQv40OO51u+7evkMBj6dSPv6uH3x0zz754Paec7YGCmfv26//3L/end+e93
62/VUN7X9EE7/hjLtP50WDgC3RKa1hIOXBkNsb96s71pbE2kBx2HXDsDkWIDL50wM9thPFcJxQ5K
Sr7oR7dgEhIt7NpZo7Y2xPJhL734SBK6jj97o8+STedrGiodzY0MpVlgsAddWnM76GuteuiBYORW
R3AY0qDPfLQyGmLoVfUKm3TXFF7vh+us8IYii9jNja7XKBlhabnp9FQZyj6T/NdU+3hs7drCNWGv
SAJrT5tk0xOOmr8UddPkB9GAU+Jgcadf6AL9TwIPTZcudlUEcgEFq6Y8iwgTu511a35qgRWvAJS7
kVl9pw1A2HlJ7otc5As98PpT49Ah7Jr5g26yfBBHa50YYHNM9CQGoxwRNHuKtLWieUSLpQrg44if
zrQTd0Z1ynO7C90k77eGo+LDMvon7n/FnZVXCRkZrhW6lrhwh5NRTp0QyWVKNuQyj7drTkdFF54T
1W56iUta917W3trDnB76dGkfh1ExFW1MvINuOrgBmNi5tez+uyqNOTIa9y7hknRoQNSUV/8ytOVi
2fka2nWibdtZPhfQj7tpTNatu2T1xSjMDx+tPmxxz0ciVg03SdnSgisrGhD5B8rYz4qQt4B1SdK1
vn5aTqrd6Uwh3JiSsSSiXRFDvTELzFqOj7k/vC08BA9K8ae2xMMHRZXEzzn40k/JCthLyLWN1jlz
2LceveWkLJrAc4F/niTwtP41rU3+Yo46+nwzuYPzSJ21EOlSxtaxG8fe+orHwnNZkDUjYTurtCfz
NpOW8LeKaSxMitYc/UaZiA8bn+j79JgOtOm0ua+Mog8WbSR50xCNNKbIGg1vGc5ez634HvLG9+qN
1xm0PX8pNKhluUncobv2SUWiTUmCS0035LFDQ6vor6C07Bq7tNKNSNbhgaZivZy8WjfaKNFa43Fi
KsG7u6KbaVAn+yFLmwuign8ZaS/spcn91pgdhgCNfXxFH3vnjWVLRxemJiBZz56CXi/7fZq3DQJ8
pn5ZidUH4L01We++7hynKlluhyR3O8ArFRda99JJQv9DN8vjMB8rMI9kkreoY/cJAG/UcJMNe09D
MIcqTAUSdsYq9qZBjaeS/cI7mkaxKHfHtWhe993iKq5qs3aajELfez4KvohtKxSatiDQEpKVSmYu
3HSK6T17GI1Mj7pqjuk81fnif/hpE++xmilS5VFV+kCQ6rcfYi1BRume07a2f2pTDSJQjmkd0ODl
wgc6cA+SuOxcLp0bXzN8skwqfcsBy/X4ykd6xOoFZsl0UMruNy7vGip81RyMydaiNmtwK6bgf34l
84vM1vXYCTzMeZAIK/PuOmnKExPRq4NKWh5YGyiKqLtp6yWifavLRTvVTGqLprr3zh4a2XuSSPSJ
mWWfLCsvBgpPgErHp6zI/dMkCqYWTt6u64wUrBU17UTt5JFq33o7hux1B/q08CwgXYzSVv5Nvvre
7bX7GTGZWd/rQmanKZ20kwdx+ixtvQ9hCrug69pis6zZoWNa16POcxL8/pF5vzSPghys6636+lv5
L0nLjhVMI9VbxNvBz5V9+/b7Haw7pe/rebUiz7x+B7KZvukOVnu7TN/zWpOnmV7Wsa3T6ZCk1fzk
Lbwk7L3xHYRyh86Gopi21N7V2PfbTjj8fc00bSc4R5Lk0VFdemoHSR8zmOYFHIVG+BW3RktXNl2l
2fnhxUv2/vvn176Tvk6uQ8Zdx2foiMq3v19DchTmJ52uwcFr4RjPCTLZq86j95V0tneuaBl8gW7o
l65ws/fOLaoIBiV7zwervSIa68dcjmVUMnGAMINxYeubO+dHbmjzoU80/8nt5vGxpavyAhuMVJ5T
gWZUh0GDcegG+0EelqY3/ZKQCGeEEffkG6sfGkQuKO8V2NTX3IOKs1nPr6+xY5o86mtdjEcLgSBL
4ed1A35emIaZwg+poT8KIM42UK6dH7Sqzp86aVvH2V3mXT85d3GtP/ZN/rA41X6uLAaie8B39gRH
1B0qd9iaA0i/ZX0oz6tDPUsElEdXHXVkvSBV3h0KCwvdM+69ZH2lUVPjSm+uIRQixwRkwNXTl4rE
OLCYlnXZyrZvA1RZ5OjBVngqIBKAENDPNHkNWPL1oPRScSLqo9vpaTWEDtozCqhLGymxk33rsMS7
ySmNcOn6d7fBlzYjdQTxtLxYri95/eun3Ix/Dm38CU9RR0alPRrt1NxylsBOIVrsDcMsN9lAm2dx
2Yopzf3NuHrF3u9z55m++xyZ6dq9LeAuG3d0tVMrR43BSSlUOhnRO6dLDwYBR2zcwvs1M7BmXdy9
bgDNLQhKgSVXcKh4OGntvOtimntgQ5FajPzOzDX3rBiTEXlTT4K1K73TUpAKkuf9piwdP1AqfY6r
JAu0KV6CqemOTZ+9Nv26U445B04xMrXDs1Zk45x5vHIJXMeowqI221+97olAE50e+YhzQSsNNyiM
Zb+iJm0G20Vk8+cqch0/1MTkbRNRH8QymtGSOcUNky7o4UzlHNXV5G3o4bIN2i4giA5LpLfDgec1
26FSOZvBUIfev+7V9FvQIqr3DH8Lh2JvXSbhWLtkGuPQjhv/vrT75sHonCm03EKPGPLnPdata+6S
arH2eRnPdaAVcqY13En4ZMNdo8IV1X50DP8SJ9aBatDLIlAZ85AXAu9OqlJ5izJf3F1R+C179Yhs
u2j6pfXi9hWq02mCdpTDwZPI/hSkXgZlwzHCnaw/un78JUdvuY3hec+o4kVY40+IPKXKi9Sbmg5S
k8AejwbtsjYuOPKcPorFYO1aN2e9ijG9jfWq2bY6kyBKlQv8FVpdR4PTrD8rv9J27mC30WwDvK9r
Mh1wTjlHbEHjVs6NdpKllx/sqjNOlpO5ewBE9wubsmJJZtpdVrcjyzTBHuG3jENJK+MwOkA9AQaR
GQOC5pfRKthkUse3FhCgBfgshTmhq9QrwEWpTXNgOqnP2HoIbVdhCsJ5os61rNsou2bn1Au2BASq
9rGaZA4QScXo0O0OVe4uP/Es9EFWmDIJk9ZNHrgdTJFrj+ummqf0G2eHvZmg5HbwoYUTpJbNoliM
NuhLZQc4xFQUr9NyrybTvyg63JTQ87Zzcu12whX3yTfO7/2pLzZ9w/4/6v36PM7LzokFxLjUsgNU
+tGawJWdfFm+E7N0vjzl6sQ0umGjkjySuSX2MqN1a8cxzBmEDgei48ooreOe+pgzCZbzl1/SO3YK
1w04k9/6fOrORivri8jBGaeqfmlkm29Uqs/Hqs3TJ5+SMQLBkAcAoiW0egrQfhmcTQZTuvHc6hcn
+gNGbbrtHGWBr3tEJA4PsS7oh5vMh+NYNod923KaxAS1XsTiyYCqhl2tmd1XghmeMkr7Y2J3X64/
fAKjU3vZCONVrkRYTAaHWWKuWG78pGq3o3kVzjM/GpLs3cXdsJ2ILgiMobkDC2yCHIwSHmrgpFUC
XkhwcCaeYwa0j6G5Gfe4GXv3XFaVecNdpNxV85qFM57KF10IA8+TX3inxGI/rlXSUyqboU/1HQxA
Hdu5Yh9tudsFiVaprdTNdw/X4Z6Cq3rvryuCIv64qDQNNLKU9rGQ6jIjLoeI7s2pTGlEy8yMo7bw
x+Ogzytg3PK4VJ6zF02j04QjyG3spiKKC3Fb2c67V3TPWSXMre7m62bpBzs0ckfbdk3soPoXOQ/9
qh40MILQS7zrm/ptSc8NZOMM90k9zZs+b76nTqPQpckckOmcw1SO1SPK/nBhmGlfB6Z0zOOqAY7a
NExZbEP80jVKo1dlT852oloKFrU2h1y2Ygd13oZz4X8yuYLut0PsjRC8T6CC8WHkqNsXlvaU19bB
0ki7jsWk73tLOndj3pw1Yaw78LbkSG8V+xnyCbtI6geEPztbxSBasJMOkJGXMeDYtqoNl/TkkNiC
5UwFHvVy1R/i1NJeMQ9lwRjPl6Ua3vGXFM/V1AaiF+oBqD57SoRp7kbRWj+4V3Xb2dO/GmJhj741
sRe6zZ0+a3erXt+WbrWbaKHdVQkmAKWyCj60XA5GTbuBhfuRz/JG53V9jQ18V5TrvI84H7pC+sfc
GbugBU8JeztZ4O1R0keT+EIAQFNn/I4SN5Poq4dJeP2WkY/gXzG+pdzM9e3or/0+LzAZiisMPMYJ
5Zn2063S4Yxfao6sUhu/MUu1L5Y0iMsr5dUoPtl79q+Ew1LFL5YtqlvGL07Y9+z4PGEGvEliT48m
bCKRJal5Yl5MR58STFhWFa3Eud7JOs1V6NSYHVExprPd52lQGSCltoW5Jy2H/jZjcw5TzZqDdYGk
luZCyLWaddw83OLxxK1flfDXKJvT8TIvBdjW9R5KseIEi+htLt7N8CFSgXe1NRdGYQGfcevBgjRr
/Uc6SiolIurCxbDNnYODEhote8ejavyw16kMbS8zjtJuBOt/odbpxdsyFUnYZDM9Nfbs14p0td3U
xO5TgR/3gqMA2tJXiAvz1XPo+2s4JgskQJVfIJI0AGXH2lZm8eqh1O89gM1IjZ6LD7AZD9Poobim
zcS24chm6yxzfM9fJzdNV9+KtcxVMFiT/bhm4kfrkEFL9z0dgkEJ/76qqnUjfbP7qB2S0onX5kUv
ceDTS6ISGXCYU585Q7AyanUPIaKfKieLI2/gDkW14V+EVYyPnWcm3NmzzIxUbS0PQEfGhrtwvqd/
mVL/ZcMNV1S6227iHkbCcaOhnfKn2i/rB6taOAYE++y5sYp1XxZ9e7KuDtAh9savZc7Zx8vG3ENc
J4+lben4g71qM9dCe+stZ97XPqxf0VbqrtTy5gfh+OroQlv/lJUeb1Pa0tueSyQlE0MbSUrVt+ng
GvtyrYcro9jc+N1UpUGj3OKmWOzsxjQRPsxRbTD2LbuhtdcbYVffuj8ap2RK15t4MqfAEMMMNjn3
VAnwhMi6S+RnSbcn9T/Z2JooAxUnn/VsdZs4iz9gGYdd0ZbnlmtVt3b1XYvL7OI6i/MLk10RWEky
3PRUchetja9BgsOKF2RM1M+qsosbXhIZuYUndtis/QhIsbu4FNn3A5eovVfH+kkhJoTol4UR2M3g
RJrDQxD00DmB6/t4k1S8Vi4L3TciPQXqWlNSjoOFbujDBHi1H2Xl7iZUOtylJYAneHLot4325qtY
hLq9phEAZvlI03OGbU0UL0zaHBVlzrZTaIe8vlPPfcYmcKmyZnqiEJ/pplxIiamtLN0MfUxQH6aP
25muWkihWkakWoufNaAs8lmSgXPqjbMH6C0fIJqsTZUa2rOD/r5J27mPBtj7XXW9/dP41rdaxikK
HX7wG73f83ulB39GJEJDKM5iZPBwInr5q1hl8U6Km7FlUGKxd+uy241MI/zRKTYVPfHbAjtIIj4d
s7FCVa/eu2fX+SZTREqvdu/tMSUAkyLHvBU6VsxMigSUbeiNL3/Qq5eelOciMIASHgzlAUqvmf5Z
+X28ATNow753xfeATBQlMG9RnXlzMCxZtcUkA5kOE4gwMqsXpKX4Y6iy+jbO+j7EglDfJIr4p2Sq
pk/pD69WIvJbsKxmD8RFwWIzUOHnMs/iwZx1fIpzNv/wMCKyNQjvY5RrelKaPu5zDuQynKfFeehs
DSNRF7O51qTF44fhAl0t2rGeDQb2NakMheJwqUnMpKFcVvo1m9TwznnuSSxTg/ywCDWGxC9k4gSj
WWb3PfadqMBYBb7RSRjcrsW47Wj5cppWX16n0lldIEtYIrPPI6HcDjYplRwmmTGeBs1vDggS4y/w
WIY/MUfwrpoz9wElLT9jtk/eC7MhnaLQcEi1EwakkRbTK011nWBZznbG/61PInFiHDK4JYtFM7em
n0zHGld4OFjXR1zTtO9BwS6ZurzvMPzdm6U7HwHD0cbyGse60bDv5esZahs3IVriTebmv+Ek7B7V
4t+bM0YtKCcvXADizyrW4yP7Znmb5gZYq93MdzwiPZ68pP/yKXJUnXxYpv+h2fqjQDi90arqFcTg
UVortc6ojyBUUKUuS8VLza+yHDBDWf5PRjhvCsBd0n7K5IRwWDz1hgDRof+v5+4zPAZGVzzhIETJ
lgafBVusW5HBE4HPxoxsitRAU3ho0sI0AV4yUOVk2dnNFepXE8Xjoo4j5MpjqxH3QUf2PKaJyZZX
rFvcjWSVG6Z5hLIeo6JfXpJqeKsbv8HmPmy6Cuqbm2aAn3c8G2TYBnFc7nnI10AaWnxWfW9GKwL2
ydWrKz7JOMbAnCjFLA//M82p0Mz67ABr3u+XuVt2C12nSPfzY93G/ZkrUAbAO4uP0c2yKE041eVg
Xqy6gcnxta0YLRmaJD3sFEaZb0dX7aOTdxoIt0B2tbgkrUuRhVZrOPspBQzXehyuTmqbG+5NmITc
IT/D+qGrln2Bm8zGne9l2duA1TVyU6HfZ1mvnWWjkaCTrYPYeEPr3zku8q0vx6dSFpgMOjdmzCj2
oabvjbCxrWKL+ym9jD3KgE6zL+qsDrMl1TqO534/EPxz8PE4nCt0oq3bTtyRLC7Qbc1r7+l22DqY
OKzffxnL4WmulgefCOhAjjlGKpJmAVgabK7cmkw/HcHDdTeUNsTlgEOtcyt1C6NHfnr2qrrkjB/o
S42ZFgGljBuyNOStnnQXfdGTYHR76Hg9dvcrqeWRDta6Ebb3AVLXchOp3pBvGNmsO6wu00sPi5V4
oYqvNXlpbusZbXcdyo0mTOsyKosFMJXIzZYedlwVSGVixGihjVqQ+xbZzPPk3aU83KEwldyMUDEH
r3Rv+r7bdmb9Ni3gn0sBmrA0Hkna8hUrc73hahAHDq2fbSPWbmvnmLKMZtXJz2/PIqufZjvjjGvR
WyvLualI4w0sjBp4jdNp01juTGDcLDGNqa1TCJS7FIapjmczMNvcenK17sfgI8GZFsJ7orkzp6Z+
inHghXh5pojUre4kvOmZvGmJcFXr5Krob5lnJWwt+bh3Bv+pdiinIN/nM4bXLg+5ZzIAUVlHuMkH
sjXofMzFeFugelvc8DW18etZbu1q2frm+HNM/Uc7Ru7I6mzHbj9EeW/G7L/KOwxzrj9RGmY76X+u
GGfQ5irEZd1/okZ8TeR8xyUCv4JVp49ETX4t9Gpuc8PVt4PuVmehGV+4NRGRFMkea0DCKNaQZq32
kzWkR8ubd5yaBXsaS8I15LRbriW+X1RbjJRfY18e0tp8jpv4GuOjP6yxYKBDUmY3LQmCCdBiZPrV
u+OlaFdwgByEI22rWHSH3MJsv8QcIQwyr26wSB65ASXHyWX2sqkZn4WhnpJcvo9SGsdEacY+n7Ji
X/oFXSKK0VPSJ/bOolS70Z28JXXDm7B7++MGy6t/t1jml1WOxWOumzNuJHJB7VSpC6zySNpAWkdJ
OuAbNmR7STBR76pq+IHpuZQ3UzJBvzyxpeNjgAMIrGJYdmZJ02YkseMnaW5GBDfNEsfSFFJ7HfqJ
OaJLrBHwZo876MdDMa0/yJS56YgcWa15Dpp5OBb5cFcPLEBpx/nWKLIfBCBdeL0Ps0VeAQybxboL
rKXRNyiquy6Xj3MXR3NGW68ZqvhepnwSsN/pCtFEWqce6KI9WISCDGZ6UARS4MrImSMTb4xy5Dds
VH8ScQ8Smt5Dkb5oCY+6gn/OrZSPDl95MedRrBkfXakfMAzSydWp9obsrHTAcdN7NByrCEdRHokm
ONpWvnGFBWWYgyJltRHQOxsCH/Uxwp9xLOrO567YENLSVm921lMCV+oHfuh7O09DYXSPAu9W2K2k
V9BlTLkJbujhqjd9zW7JAgogsiOOqGgu1DOeZ8mlhKQCx7q1DNVtjIUQkcGPl9skrvd1L+Owhdsm
vR+TtVzoY5majKZk/sAk6R611suPozZheO/jN/taXdgaVRRzDCLnGuCgBmK/cc79KFMdMm+NzyZX
EnsE822bmL2B56jwXbqztX+X0BzYeo17TDAwnJruOlBusSr3FbHLDrjykQgd99Od5+qnBktW4HCN
3JQEIeBisNQbPvr+foaaxOkr5dknWxKVwMWfV+L2LCxnh4YiD2mnOdveLMiApmmoXkSTTR+ioWgn
P6mIWORV8S4dm5s4tbWI2fOVtWgbHVZsM1POaSr/chxmHTNOL6XZog/R7K/JSA1Gv7YEuM9jZCWm
Ibsbi3fGcf2MAA2L05vSRMRGhGdhQw7QHCQoFXJ0H6Wn5/vRnccNaRifIs9RFWhAoUcEwyAPvIMM
pK5qBPOhInWibtk04KbNqXwwSmekXUE0wbC8YDk+4nvAB6jr986w5hvTxYVSYvcs0uF+Gs1n2pw5
Lgh6+5pDVEJjJO2hWtslamzvs00ag0u3PuzGzKmfhnp0j57IHvrVOUBMWtuhseLQmpkdNoj1YqqV
yOF2rI+EvkROsRT02o0fY483aGoU1kSE907o+cXmHXXd3AlKaVO8JkwhpOkZeIivVup3xBTGeTR7
8W1eJg/4oSJSnUgy6LE0cvrsx7TQSa2Jt/Vg/+w84+cwMmK1pV+4wSdkBG3WvyT18OnrfdTEPm0S
h7HUjHpiHVv36TCpbV3A7RaF/unkstwzSrsMiK/ydm6eupQO5gbjQRMNRXHCMxAlw+Qcajf7odU0
GvLCpFTsbxlVZ+1E2hjbtWsevNjgOm0/9I7b3iVEGkVtPDs3bS2GKO6RrseSU5nt0zp6lRu6U1JH
9JfTIy4osV1BwfZ+TulOaxyhnDiXG2wnZUhA4YvhY16uVG6f016euqpjTHiV7I14viMuQlFOcNDE
XDLaLN+QyrqhK8k4D7hX1B26s1hz7yYGmQd1RxBQ5i5VOEmJA4Bm/CYVFAq5h+GSNrg8FB6CNIYU
N9K4GgRxMd7YhXgcVywIsz1dSG5BQ3T1l67L9MBOsDTaSZ0e5Gi+WzMSRV2e+wQkfTGr4qwTXUAB
6hehQZYjFbnFDafUCHIIEi53TOuZMjRN6wUody6AYxJlWN+rqeImihs684EDcD4erHpw89M8r8D8
oN2FdabfagCI2WPeHjpPM4ybhmQx7ITECNBlwpOgZVu7u7og0cjbd4b9MG7G7bv1NUWGmy8dMpEK
JEIjuXUqnexzzx203hQYo9N7zve4vSNRafm14mdsAfZ0hRZfuq6+L0u7zbcS90hiBjNtkDosk6bW
IbNbzbiB7KAgZH56+qNRU2Ld9rZw1YNJw4tqmnWfy5vZlvXwMLaxT+GKmRJCHP6oOhKM7g9b8t2h
+OhaDgzHJWxX39WO3tJHztc6104YSVcsJnPMHxfHNXKVbQmyTDJ8hIZJHuRoyJnstWkWb1UzrfoR
jJu0mgBjjtFvqHsc704CRrCOmQ/l4Bv0lmgyMjkGBszaPaSEdytc42Nu7HuvxQ8scFOFhVPJXZ93
04Nn4ZNtMtWA5cUxBLMckp/Mb1T3Wq6NxK1V/WqGps5ZGuqV4R2AOB7W0bWfMNW/JYCvTpYibhtx
aJZEqia5de9N5RdznCINuganx9KKC03x+phonvJCdsNhfRFy8LxfDKoxrz9/dE6EVj+TzeWwwZCc
lMSf14CVXVm4Oz9rd2qkBm6Lm8WWBulRBiFcWS1pc6QrDRaJouiaWxoTxaEb+WCV9evBKOsiahss
6ICO80uz2nvVzvUp7k0ub5S9p6lcqqAkPuZU2mkaudcXqbLx4RGJsms1qz50s7/sJkt9VJp3S5BE
yR2pOU6KGo/bEYlw5drMPJaMNtAS9lF8UkRRMGsTUsU1nmMA10CbTedcCF1EKJMLmEIWH7SxFa/L
PGBLntZX1edfNUVH1M/tDp9/vHdVk4VJT8aBXO3stVL+l7l42WGoh9vabfNdPU5P6Szn04j6dWka
r9jYk9tuM6n/rHoGTMq045SxNLTmdlUJHlccE0E6ZvW763GhxSmyFTM98DntDnGf4nGGS+NS1dBk
aJYjDTlr7/ocgv5iqo0wpmVXJMQFTQmDZ9KMm3LVzRemHTqBYzOG2DH9DGk4TiS0gn/23PZBVJ56
cn0rD7JhdS7wev6eYcVuROOk+YyngqQs6Scbv7Fn+i6dse9G+K227bhLZHRh05a0IYu/PuCc1YKB
ULwDTzuaquedJKDMV0NTAOF+3VjVNK13nrnoYYVPOojJVQumOP9BrlwZdZKjjQlzj3k2zmHpzd6G
FuvjOpflmfkrtGx9Bp0NOCb8yC6z+aUWVkkxA/90pJk9EESseO1JgKsxJ2DgWd9Bv8yPwsdke+l9
Lof4ckZjy8TtGRJgqbNu2+upfrSzUn2s2KFhSYgzsm9EgVqKq0685oRj0D2s1TPUmn0CaBxCzaJ5
Oaztcb1uWcwcj/Oz8FRFq6u6KUABw0ZHc1G4HqPpWtwYnbbuqTmyF2Yqp/BM6XQ0u3g+soFRWHtx
kYetYh3ghWynNGyJTrODrpqUfjRMnafP6ofZ++LSR2z8ONj+xpvj6gZQP6pFMx1JIxQPmu10R28o
zWhONefeL+dlS78hu+2XtHpIVfVJvIl55iGuQkyE2qXOy4vpeurQtpp4pOWxM93i28Z4EWltduOM
NlvhKsRFDcaAFdogwG11kiyGpEnX/kRk40/sZs90FYdokesG8592yGKuyKaUD3NOk04saFOcw3uP
wenfGPBB+30sSwujS0w8+XOzTgd2iC32a2oSHpJNqWXLwCLPRWTYscHJ7OTnxNUfR9LC6KgZO7pa
KjDFdFKiNw+mpRHVxmS4cJTTdvVyXvtp6uS9q4uRcr6i19hDBpM2mkQ2zf9nU/XubeKUbsfFsOtD
gvP00PXM/mCk+RJ0qdk+r1n+Ynkmh/fQfHEB6h/A6yAY6ukxZdtdYarm+dtxxRMCkdwO9FLowj8k
pZ6Gceu71N/TEyUokV86+0Qz5NM2H9QrJiYfibaYjnGn89YYPf3uyamut4upnXQwm2X2++wmsW07
oDnuPjM1TJyLyS62QApyN/vmJoPxWfxy3XBZDvjZ6Fv4KNHCB6felLCzPU6hphJb09A+Bt1zNuhE
3sGcpX7rDYvgqWOF/S/izmxJctzKtr/SP8A2zsPjddLnmOeMF1pmZCTneebX92JKty2KCrrb9Zcr
U5VJJSUCAQIHwME+a7sSGpSuBJrVKZ5ICZCm7xRe/jtKbKgrl8ZIuhmz+j3Siu66iaRoG4fVsI4b
Tz3y0FjdKH2hQh9If6fMRydvguhYlEhSV0nqfep+gAqoWHeQe8jqXw0yK80qHrs2Q6rmQSaipv3K
EAywFa2/SxTEGnChJA7jaWBnihgw1eWK84+F7ELPNgWPDRWqHp7VD1RJ7Rqe2+AhxE5SNXZbonag
iOnR8uobSpyuEhlN6xjBasgTD/GsWmqRE6sGRHTKr6/CsBSQ5oT+SkOF5JRpMdUJd5Kj+9T2FqBJ
dlWp5ruGxBu/L6KuwBpeEqnO7NjwSekzSlEVeEh2Q8AhffggVMKLgBcNb1ewZsBAuKsazidbvXaX
JW10jFNk9wOv4dQEV0cBkt4GoeeOZ7je8SWO5FlGolKJROhokfkjxjiRDIrwoUjD45g3sl2Tgl9H
ZXvV4eu2EVptBOw0cj3UTPVzSkDvu9H4lMJaNW1Jb+t1xFEBLfw47lMG69rF1YcbyF9h978l5v8Q
T/+vbH0ubb8OPuCEZn/quXD9H1r325aa36b8/K/rn3n1XxuyMj9rVOXzPzP95K8/6d89+f8pdpdE
FOrLanfe9bz/Ok5/e/w/D18173//3L9E7+wM/63CyNBV9KGawcP2/9W8S5Ly3yYP5appoWY1pYnq
/G/JO6p2zp0YVujkG2VFnjwCeEyfFO/8T5KGUJ79GL7s9Of+XwTv31odIMSfVPBfajMoR0pIULfi
kbyEHY0H7t+2LDhfBuPfE+Srmn6pcTr/tfF2qJK0kDuAAHoGN616yQNAB0Sv081/Wz9E32clPlMi
l9N9JR6RO/DUsXLFc+7CU/Xbf5SU0PKsvscU81Bu/IZUB4eWGCkb5Xekw7PtQKpTE2xqLC/6Feb4
9FSRCjKe/KDSROhzZUDlOd3wwtDP4elZI49yIJPSbXgU6GX4cQL0NnO8xG5PlOcA9UAB1tAV0wD1
jp4/GzmVIP+7fL6ZMdNi+G7kpyKTr1OG5BFg0DyXjpLK0VfxDlOSuk2EDS93Oy1qb5uoX/F6RB7E
2wnw/YwSp5iaxJyWX/WWdjs5ewsohIAVXoecKNhzdB2Udt/lZwruvq2g4nefhvzLkslIRbZGJopH
cvBv5HlXKFqdMfpjkUfkhrw9PRILk3uOY5dirkhuxghL6btSwpoNz6yapZkxW/FeKpRAnljxZBUG
6tv1nsKpM45eC+vm71f9MjSYHvc1teziMWmUda6sDQ7RofRh+LdiKe/c7MyvYCzNktnK9+pMNsAu
ikdN+dT76ljEgS1UwZpbAHuhm2xBPh8UUL9SFsP/0Tae1DwnEYQFHsE8s1rz7IIkGc6H624bhGKC
Md4WOqeAIHJ8zdsknrAO1PQ6dDvHNGEwc/nf9SJUcRnpUC5sZPQLoyqQ+bBswCzonl764RUh88bv
taObX6eweCgQsjXkl4OY3jYCCr9i3GSAeaKmJ58Q0RNtpWgQ5eRNjD2s5NVr+IlbAo8TyKCXxcyu
ou5GaN5b6MB6+TtDrdQGw1ot9ZWLChNciEE+gEJvFFoP4QiwRynvT0/ApXkyi4FpF04WL6F4HNLH
ooSYdiVB6T3d9qzI6t/ObKI8L2gOw7aEK8ca0uHjJiPpwDoOVoDFbMCnO4hvUK7WnnoXkMsl/b+B
ycULr+l0AXk3hEUacAszFp6U0tuZdXOIrPQwsJc5gheSnm3PTDTr+2g0r45OK69o8pL53CKO6eS3
SPBX5fAuBYOdlW8jcvBIPeeApU2T95tNZ14pzbLsR0moxaNiuq9DKG0q8256k5xekkZL2A8xJzuD
paXd1joI/lqUoN8ZRyVA7zu94CDSjhvx1YuhmvvIRTwmfClpxxyFsYlMLorzHSX4tmyp3JRGO5NN
m8cpSylWhvpDY275jXAlVbKt5X+kCY3eUnukm5OabhXxMkhx+1ZGEomrHi+oj530kmXXLq8tuvtk
Rp8ZkImk7uzTc2QhAM6Ltl3BbLomYexlxEah2Nu8h5xu+W8M/W6kpyn/JUxlUkxOQZD4rJ5mA3ni
2gR8o0duw+8prXtKpqSSfR9WifRuDjtjRHMs4YxBiqFECKmPrz2MPyRxbC/SVRjcpzrPohIldHLt
n1kjS7//9M+/dFLPQqVA/T4cKfjcIem5DoWP07//wgYmzXYAK0CNlKcyW4t/pfE0Iqh2oPxOip2U
SGfOBwvBYyri/Np58rAhGng2mVpgx35pu59c/k/3fmlcZrE/yrlJVTzbHi2LnORuOGfdtDQqs3iH
3UlKLT3tYszhuEBFpYqnzXJv1v5OLR9Pd35hXOal3Xqckvqs+CGde5fpN2HxoYeXOPGI8rywOwNh
jMPqIB5xeE+VHbyN011WF+LSvHyb7AaPfm2P2g6X6YQ8Lw+B5NtjJxWtlRaaeyP4ARkNYcFzQAUW
SeYwU5+6unaM3ANkX1FIGNs47pDe4KGtDfAKAjukJo4mlxveiDbtWGwFytChV5NN1MEA3FVwyVrj
hpwtsoufExxJGPa1Zud1vqcABwR/7r2qXnjmTLcwqeY15ALPf8ng8rZplMJGoVbCOmf+vtTyLNbo
+HMBtk+mS8pDCK8+O2fetzBfpwvqP5aY78bkefTxiKUA6a5oI6I79PX7nmq3qXjlzNentW9CpTiL
FdTyIDoH/nNs/a0g70v1zEJY6v0sQOCoF7LiOABgqr0aPVQSryPIH2S1YGMui6DiLFKoajbxXtzx
GHsfsDeB9NmXDco8VIQAf+SEnbr01y1Qk/xMh7+PDpI1HUO+hPyu9yXDcOXxqFfIdqj3GlL/VvDO
xOTvZ6JkTYf2L61TlldWSsBwJICb6ha85Dn3taV+Tx/5S8teJFKfF1njMXMfgeXzbs8pvDsH2/h+
qkjW7EoowjZFXVBy2Id6bkRPvUilcWCH7Nly9/v0F136DWarNBjw2TX66WeUu1p9NiKUm7V+5rMu
Dfz0z78MT5DFJRgiVmqGfoA1eu6Ov9TubG36Y5vUZkK7zU9Ef+q549FSs7OlmVP4jL2MhmGHuPOH
tTs6p8d4qd3ZcuzBbPRlTHcpJCcn+VjpZ3a+pY83W44UxaA3mxoGUdiK9yDsfeUSdAlcgtmKRB0V
dG3HWKQ5z4EUaz1cNBbmbC3KVhUK4fTpLO41407TLopMkjlficlI9juf+utvjYesWV/W3dkSlC3u
IUVBs1FwTZVrO24va3e27KKCQyJEQkKSd98r70X3eVm70xT8suKAtQaujnrwGBs/++jax/v0soZn
S07suwJ7C2Ko2TvURvnRhQMxW3Ox549oP9TxqOqP8vhYn7vALsROcsT/GAg/6AbcjhmIML/Xo/q+
qRIyYXgZleaesrcLR2W2AD3QnjBC+Cm+6MOOQFV/zr9+IWYYs/WXt1XB23kuHkd/XQ/7vr9sLzRm
6y/xg4h/K0zoeJdpdmhdtlCM2fprBGoFCpV2By4NKPO8i86nkjFbgAqCJYFXQGJycuBRj+f0i+az
MVuAXZ1IzVhYPUg2R0t3g3BmRnyfOJH+A57jp0D8MsZhtH525R+1ibdDU9mKWzlWSdECxND67rJf
YbYkI6mUAN8YI/dkUknNk5T+Ot3wNAb/efSV/iYfvwQRHDtyA1DveBSpwpBFcSsPbAPa5nTrSzN7
tjKpJbdikbrZI8ITbCNV23+/rOHZYgwVUclTg6Fvy7Vu7Nzmsg7rs6VYp3qRgqDncGqYq1G+DS7s
sD5bi8iZdYmDDLEvv1OSfdMcLxoIfbYWS6VJQkoapr3wGINW8odzzuYLM0OfrUYKbyrFmqKHRS29
wcW2ofoL07XT/f6bXfxm4umzRSkacueZ0wFMCt8r1HE+gj6/2Qw8EEuSsba050zCvYtqMoqcVxQ3
YLD2gCpiUDcKxbHSAJSeWvgzvZnmzXe9me2lEOEzQaEk8Fi1hu0m0UqdjHGkQ1NjDcrKwEcJeu5D
35qr0z9xYWXoswXdZgE/IYmHoxv7d0VO2eCZoL/02WabbA8ey89jfhOj2U76pMy9xTHtTK+XGp+t
57ri6aqZZlutUBITRxtTfMSJ4sxXkKdmvvsKs1UdGzrWO6XcH+WSXAry96bwkI43tp+9Q7FzBCul
Cl84yENz1FElJlro5JTYdBQG1bB5NZnaFXwSspRKsRCzK0M8TKTbiz6ZNosNow4zA5Pb6QBAfV64
74dzl7+FyaDNgkM/GkDWyynqDLaU7eH3n+7xwufSZsEBtw23aiLapQSjzyhUQeoqIt4/3frfd9Bv
Ppc2ixBFCA0aSjj7NTWSQRhvKOoVe82OcI2EfLHtQ+WPFb6KrQW6+1dqPKnyFmngSkt1LBV+x516
bNXNkL9S0LyuqsjRkwgPSd0JR822YmWfg8sWHk73durUd52dxRu4INhfIbOknBYqU3BfURiCzoWK
BuXM4lj6irMYwnNPU+A8MxwzwOFh/GeoL4vx2ixWYCwBXoVKzqPI2x4Xkwuv1tosVIxYkSH7JWvX
8U4iJFTAIDY9PdpLYzELFEGc91IfMtpDdtQiO23PfMWldmcRQqFmoZx0g8fa0HlZ7GyTquiLuqzO
lncR49INPHA46jx6glN+vazZ2dq2WjDfeqwNxxGbhDuvXF/W7GxpC7z5DgDkKMNNHe3m4mZnS9oK
oxo6houY92kM2l95XH2c7u9CKFJnyy/XwJiUNQ+tbbkLhR+9GaxxPrrs4qDOVl4TgvvzYY0dhdjm
zbC87JCpztYdZHijpkxsOGJHQwK3uLC3s2XXu+DHpIxmlSvtIewvnL6zFdeBJs9LgAscBO80w3iP
BUqjz3y7hdOROlt1WKP8e9W5VWZL7Q+AICuttovM3WBPiYsEjkrePeQl/Pa0lZbBvqmttW9+Vm5q
10CUIvdREKiQyY6Wec/EtQceOOSnqHzVCy7TNWrvcMARLl0F0F2odV+n4UdXCnsNWBYaRSot6+6g
441u7YGQwG6E/kOF4coqVXsoIJPq6wSc7ThCLBMhAPmSLfjPpfh2egQWwo4yiw01pK7SxKntqCLq
1VG+Oqfb/fsa+c2upMyiA4S0oBg8Ec05uhrdeIS+YEcSZajdmyvci8HvOP4Ukseie9Xad8z6znzR
pd9nFj3wfa5dfOzI8GBonO7U4er077PU7ix8REEnAmIRyDj8bLPdcOFuosyCh2H1EQTtqdk/Wnag
tuN0bxeOBBOf92sCjR1PGuLpq7rhq85hLh4fdJ1igMse96W57FBJRk83FbqdAcfBkE49k8+YvtJ3
k2YWQHQ1T3V8VXuetlN0yS5/QXIIH7T0R5ucO4wvfcpZPLHiWuEEThJQardUHrq5c3rQFzaCueqw
MERouur0LRMosuIqhPmleucelxZ6PZcaRgOVAXpErzMEHNm+y/ene/33m30z5nOpoRvnaMrqhsOd
eyV5yr08HLxOhVHxJPrPPmKsUe0csdU2cRbeBZK0EqQbCVF1gJg/rIqd5pc7TR0OKQ+Xiheti7xx
xMy4lwTNEQRuKdhOpJ9NviuDJ1HynVSiwJEHoNErnTjqzxzZJXFh+OeaRrWVWhOBLMnoSnfg4K1B
Bjkmb85d8Tt0JRyMIKN6Cs/DsJdEyhSofRmhI0Y9thvmSmuMfc9pvyrxt+6QpKWOqTYbQY93ERt7
qa9lHOpc0UOlpuIFzP1MTq/0lOI01c4yAnaEmZf03Ku/FZnisejNyIVHVWo3mpzcZtEvsX4xGnld
wTrzPcy0qKRV0hLDOKrN1Y88uPJ9nPQ86muzO99/jcMJfX8tURza9+jDtH0KFaod71tcAyuQYiBV
V6UmrUzzWckTDJV/xjEyevFHDBC3EilvLkXulKUtUC7QG5PlGmym5BlXHSOTbTcythqA59R0HfiU
o/jsDiaVeeo6ErUb3Xwxlasos1aYiFCdZK2Nbiu4mGOF4p0Z6ljoCmtsaVZZ8kekXtQP35U6uqtA
YyuAck9PzaUvOou5o6/j9DxdS83qKixxAdoJ/Rml47S9fTfpZ3EXcW2hDQmBZgJUeNHvAgfxtMZD
2A83LfN90KlAM4MzkWEhHM/FoK4SZQOIzf4YuXda9YQjoaqDDWrP/DJLzc9OcyaexWObsYLdqZBR
CNb58F6BfYDjd2ZXXYjLc2Fo1bQiBeaENjE94pECiXXvVgfEZ1T2nP7WS+FtFpRl7K7B4RPeOOgq
zSbu1pe1OzvgSXEQKyDcCMrapvc3SX0m3iz0d66ABNbSaAp4sqMe7XvR9rQzR+iFb/kfksU8LyUs
0Icj6SjHKFPEp9gWqXewGc4pTxbm/lyoWAoNoKXpsaqjsr14V4WbMupWiliRJadaGZe8PD0XlpeG
abaEMz1qhDTkgg+Z3JYbc4tM5/6iLzv3ammGArK0Xw1HkwL/4Biee6tZmOtzQxYpipXBn95Ughp6
ZzfsJyfTosG+TowPoqCeiQnKdKb5JgTNZXw6TjptLBPdDOUqFVD5K1fQHOxRvKNky8a4b5tbv+rh
TkCJbAY7RQWMW91qLeYYkL9DM13Vw8YtpZVI7X0nBNsSI9o+H58A3GPbtR2heZjpZ5TgxIk5YVDi
BGfDgdqcHv6lHNlcI9jrgJzNkpWV1m8x0MGib0F/c0PBHzP1f4UJDl5wQTNStEUOl/U21u8N81dJ
8W6RFnaYoNkcI0eOiuNIVkKwLKcNN7UHqMe/l6KXZACxfC4CL2wl0iy89L1gllbNc40aOV3tQEIJ
L0th/TVO+vLMNKqulxXaJAVQbGQcbXYmwPzt2jfzY641RPkEqZfar2OeP2Xmlfkbr/hpJlCtvMml
nRft3ezMGXBhdObaw0DzfGTvTEU3PrSQiyp/qxdn5TMLC2ouQGwlTBxBd7N5CNJKL38a3IWHP7Fy
lcdPcba3mr2r3NcwJy3jo/Ies7w7xNWjEG1wPQB8ZNitXoJNLUC5XJPZ25kxtf1Ns8M32MEG2Tbz
fOWaD6WXQXbZYKps4/O9SWTJlin7Eaw10OQte1WHBrxZy8w92eocVT744Utg3Kfetja2Qn5OHL8Q
8uZaxFo1ehc+NBMCy3Mqbuv2soD39+D7Zaa5cRmUncA4JpYdDHdl+3R6JS91ePrnX9o1fSkUmumY
5ZW/GgzewvKccddSy7ODiVtTF+cXU4gzP9LsTuh+nO6xtCABl8TZRXGk7LvBtHs4ljyWyNCXvfIh
6t4T6RaYQrIavHePF4E4f7/XVmWjOYZ6iPMXiXpncEsNXpcFyQ5jFLeqHNje8KcbiK7hW9wVNlUD
yNR+wKlw4nhdFdvQg+hAHXBntLZcw0Yx1JXuSaveo7CkHz5d4Souj354JUKUya+15Jin1+J4HWvH
evisS4wzN5LwQ48eg/FOqKpgE9dPVMbDrhaGa1MC2lJC0TJL6TVSI+53h1L/MXQwfTAnNN/r8qrU
cXN8TeMiwNHFWo/QhpLxj1E/qDUUbP961AGVq1xQYF5Kmg0/zFFUC1J2BQMF6HH9ZAxPQX4nd09F
9zA2DXTnOzF9pNy9cPeicAM22Uuu8uJ2KB5DFa/iwxiYjj+C8/aP0DZXVncbgQkYy+dIPebK7wqg
qg44dnC3Qdg6ZvU7rru1qBq3ZlG9DhQ9+fqr37V2JUCMfVWb36e//NKMmsXxFndW0CGsAQpLwvom
EC6L4uLsmKiCwwcqSbudTDEK7Lszx7m/t+j/jOLQcP+5uAqKQXxcpGkYtivPoiuhseCM3XsJ5r3a
Mzg+JXoLX3+4G6itgvFD0D5cjCZGc2+Zr3rwqfXJAx6395qwg96y841HKSw3GrfTzKPA7jJhlDgX
l7piDZwRHD6lT8lKM46id2apTum+737/aVP4ElyKET9PfGhRksQwHQBMF9u2f1Z6MOxOzwnlkmkB
YfqfPyUolKgBBEBoLHg/dwj9l7U7uyaaepoCo5mUAhFcTXChzul2te/zzqI1ze8vwxIBh/mXwKal
OrUM07Vl/PTbjcyhKBUip5Eeeu9DMT6AhOQBrzZVg0/LAT/tTVnuDABUBSXzBtSVYPKuG3+Vww0p
jRiwV12IVDU5AKsF6vt1KojWNbgi0Y3XgfwHfsguTT6BxOybNL3JsY+JpUPUC7ZrQv8HaTPmz1V5
G7vrGj62d6spNxrOb6AMTv/m3y9g0ZptCZYuDFKCGdexKB4i2BAkMC5reLYjgByRoGgygyV5rX80
wZlj7lJ/ZwEHrwFFSKbjnSiUK19/gzh/4dyahRxsrHOhEVweSz4ET7rpjfKM6PX705w4F72mTe+J
HS4ox8rE5plDiK8/tX17Zpz/XhO/WdFz7auf+oroY/N7jAScL3zjqHYUU8WwsqoJWq18mjxguinc
HuzOVvC/OHCLySooAJnkwDG8Cb4efFrAuS/68nPR7Ih0PaHIYTiCs/utvPqK+vuyhmdRxYNso2pS
N6JcXxkurp/OZe3OoopnykGugAQ+NlzIfMf/vKzZaQp/iSmBwHNViHncUdZfS1Adl4mSRXO2ZDMl
0Qsho7u4WfYmHLTtmf4uBEFztmRbMWxyH7OoY+0iqzDGlaU/m4myytOrCIKd1/5JB67GoLoKwVb9
exKZdqhSOdo/pOaHHwJAwc4eOu5tFlKFEr/lQ/s4ed3Useuwy7jAm1MJYr60EutsVyF6a99GGSTK
nVds4xgAyXZsyTfVt131BkHlzHVqIWbMVbuhHIsKLDMOKe9Kfii6y0KROQsY1dDjfDkyXEJ067Vb
sTqzfr6/n0Fj+ee88WFgS7Wk8I6v3nbaEK0mAI/lwwJVTRwN/ctW01yz63XK0FCMR1iSU6c1MNgy
ns5MJDr6TUSaq3azatTE3JjWE/5zFZS2yyL0XLUrZK43YlTFliJeNW/YWJ3u7tJ4z5Z/ryiNBx0b
dXv5pFPbm2a8kT433jqrHk//hIUJOJfvKpmc68DmyW7XyXVTcbttzhznFvYWYxYLtGKQLE2m77ry
o0hH+MNXpWmd2VqWuj2LB4qWqmY1NT5qGPxsKvFMu0udnu3hco4NexFwBtXCH7r1J+Y5pTT89WVj
PVuVAca4PfYKHGioxnZt9VynFwZjrtc1RM7NRobqoQYht0vzc0H3+7UyV+uC2otFvaG7hvvTk65U
78xbzVJ3p8n+ZfMZhbLEArwh5kFAEiGJXdjf2R5sjngt1JAcj4LkwJLS4jNi0qX+zhYhjo9DpRgh
byZb9659vmgu6NMP+zIIQaOV4qjTaHtVrs8BP5Z6OltynYX/S6z+q6ckLk/31FxqdbbW3ArYYi71
/bHTcjuMTBQmif6rkxo7U6tDnFR26h5rXdqEWHpHQGiChNfP1OMV8S4HhrQCB7/NuGGE96D47TS9
LtKXJH+LVW+HYacTaKMTeN0HYrk15rWUtIJecBtbgylqx4p8qEAeaMGzGdyFVJyUe629UWRSKLcZ
1htNrtlG+Rq3xT5ReGAJf6AQsVNxVPaRryF/1WMJNqJR4yxlgATN9y5g9jarDj6GhFo/5NdVfdPJ
6cGst7X70PckVI6+t6tieStXDdy4HhszTfMcUu9O7gZ3Y5cdAwFEd7eT2VGwEcRgIBn3VtbtLSvd
qp60NalbTjvryQJxvMKnQN9lAKhPf5GlDzILUlJT9SBB+czKxnsefl3W6Cw4ZaIlgggOeH7ZeNfD
mZzGtPS+2W7namG1yq2iaf3haIyWo5J7G2te8gGjjufqyqag8d1PmJIJX9aRVrtK0RVIyBVX36Tg
WjCcwMiKS0T1FA9vF43NXEIcIH/De4QBj/fF9WWvAeJcOAz+HUfKSatGQfpzwV/eZVu6NotXQsXP
UskXHkMVqLLykCMCPz0OUwvfDfYsaBVNV2LPxutxXYLtV3msQT4cnpNSL0zrucIXHZLcSw39TivE
A484Op9ZL0vdngUw2RgH3+s9SuOM90IY7824AT4aJ2dGZanfs+UI9RuTpYDZUYy31XCDT9Hp0Z4O
1d+N9mxFCkPWR4LLq6VrunaOmobkNf5DoZO4kS2IolPKwbo8V6e6oMIDRPfPleQ12Yh5Gu+vir8d
c8ups3dcXbHL6rddXG3VpLVB3q3zsiB5RPa4uYtc5/RvujCC6mwRK3o2QTyJPdEDqeUz+5ayEHzU
KWR8CQ1liBjGygk+qekd/QbvPawDTe02JfPnxoFTDOUuVbV1TowH1bgWRZwnhT2gUfaodDuYJtr4
H7SAO842Ml8S8XbMDpFHXWX7EprN3kM976J0cqX2V9f+jKrHqNqJ474p2k2P2UZp/RaMcwi8v4/K
30wHdXa8CYFmpopWjkdF4k56UFG2Znmy7kA1iU16RO+iRvshukVlneB/V0n3gfxw+vssBNm5bjn0
cdisQk7FiX/deMDLx30l4yhw7MzL3n/EuXp50Ewdx7MM8cXL+BBtTvd7aV4psxlQhlUcYwByjAGG
Jsa6HS5c8+ospGTeGBhuR3dNfCew6VbPxJKFUPWXzPJlzhYiB02skKcSx6tKftNBeNbiZbpAca5g
trwmyFOFA3Ku/W7kxyF5Oj3MC52eC4OxGRPDOh4pcBw2rSnh+vFWcq473fjCN5yLg6uk7AZNJniP
E9PeCdQzR5OlTs+jQzKUeSsx0n67JRm2SpLNlMg43em/6KpvFuvfmPTlO5ZBXNYwDLnq9Tg1KZJT
Y62piC8lrgFj2oJ97leV5DkJCOfG/CPobzmlJ1HlbgHC36vqOdTY0uhNv/2XfoSmJ9UhDhVH0XwT
spfkwrTBXDUciAEmYggOj3L+Upm3SnPma8v8i659N3SzRat2qMZwImVpae2qxi8sw2X2yhPfzOqj
Q12YKDuvvY1yy06Nn3h6IRs5oIKCCVraTWSs2nbne1dmjnGJi6n6q4mdivTGTrASE2FrSplTCdQy
gluzxDupujKUvcIfae5SF0W9hucR7g5ZsxXQTmT6Dr4rjjxbaF8Hi79i/aFX3QPA76NUfsAYXwU5
vluKtHJ7WCvqZ6ZVe9l4wrPlJqtRUao3pNjXpmZu+8kUKIACkQVOmw0PYy87UX6o8aqTUlKPuuOm
riMKmMEIO9fgaqXn1H8DfVbS68wqHK+r1jw525TKO2X4kJCYSDBf6aGXtV4H9lvcaMJLmn/mhsSD
Nv/N2nYQuLGeWMvuY+od3Fg+ul2w6ZW7cbxC2GynBRYy1coQrrPs0KqS7XeKXbd/BuEKpyc7k3Z4
K2xKNWE0O6jFGFa5n2L3s8NyTDXQfErhn5wh0tvGxs1jLYg3VrITuxDnmWwXSViGD2W/ykXYnoO4
78dqO4ggDYVPTDbvsKR0ivRPIR6iutop5ns3KW8xIlX9DaYmx1B+TfKj1X0G4r4KXjD9ssUkJ9Ho
O4Nwg7/pFpD1S+U+RGj4cTZ+0BKKf9kYMW3nSrmBh+B0ke5ozZ8uy520zqlZlLeidmeFzSpQbop4
XAls96tu2EietYmx3NMMbNzY5QUXb0Orpt8fUXit5jDToZznVD9Ife6YweioxiNZMzJGeNqYWxeO
dhPEtsU7nSyDzY+wCvk0igCvUvBZVHN2ys0IAdGsNMjoSKCtn3G/RX/sdKW+HX385Ce7sfEePRMe
pYW1Vteh+ojhZGU9ef1TG1618V07bHr+az39Z02YcJJ2UUCWfM6jG/6e8vf2ydo267HY8HJaWms7
8p2QvHnS4d2HO7pcrmTu2W2LQfT0wryu9ZukPBbyWz0U6MI44KR/TPlHFX0o1btpblv3x+D+kJo/
k82dIW0j0HeBkdhxLFzHIV6i1+747sq7UEMnnNh4D/bxbR7fyPGea6otMKASfhyehNDFcbtrKP8l
qH3xwQpE7IVQfQk3LlqK0J88V27J42w8odgVeOlVyRtufZzbqJTi1F5ihgHgurx24wFQYb8R5XRT
F4grKHrBgHxnpv0uUW/RWtm1cKO1151eY5u07hJKqhOML5/SIcMZKHaGsnnqQZfJ5CSg5F1z/1jX
0m3i0eHqUI6CnUSvY7bX/jLNj00mO7pX4Hp1KNN2pTJJhcha4VRuC5K7wmwB34SNTCAyqPULDQx5
MHdsGfIujFZNZZEaQWAy9rYpVw6OOApetAFryo+bayu409RbQ7xLALS3DoJ03sSkxoed8NMo7yW5
v/JU+aGPUaEo6kqIXkLyqiNavZS3XQ4JZvoY1cHOKgUHfMQaQGqK30KKwCluHpL8d9lHd7qpHcI4
W7lKuFWUBxdrnhgzuUwAEsIDSY+tlC50KznR2AzxmehwZcMVplLXRvFDx5glmgxVc8+pvf45JpnS
TKbt0iNc3pWmdqvSem5wipjWnunhruH3gPZvIkbASn4GGsKbwrDDPNnxxo+7E8BiipkV7UpH6Z+V
z1harJQq2PXxXqPu3Gjx3c6RCkZOqbxY+qMrvzRBeSODnvSod7SQdchKvkFav86rd68l75JWb6XY
/5LQpBqWcN1XbALpGE/sTBsbYIzRm12I97in1PuSTEQbUYMg5j8yJPBxX6xERBJNjAexObGboo1a
PQ1FurIad9MPjVOOuNQCdg+HfRXXxzze+N6mFkgR63iXP44tZalYUDXHuHrr1NumeNFlCvjvhfSV
FKqQHzQuEvw/eivBCeQ99e87ZhBGSqRFJmQs5ixI6iPlVmLGyM2jl/EmL3sbvd365drMbsOORNVL
GDyqLBY/xfXIPbiydeRxzE6tEE/69z7LDwRri5ozQfHJ0IlI2ybL4odWkrchO1+rPCvGw1ghF46d
uKPyrHjNXGo9rYiftO+86yzN1mqhklbz14bcPwXKe1oecLJeKX7uJALZOMrLUGlBoBW69yr/rcl7
peIyle8z7T73PqQRZ2lUTn23C4tdHf+S6gOGFnaG03iX7eHVc9M6tpq8csMnnEyEFlcJ9wUFkZRJ
joWLYZ5vRAPtVfDRU2RndfeYqXnVo1W8leYm6W8FPNvlYF/XD5w02ULjofsYVWnVluFaFoRtPDKL
fujpz4ochS/h5zoYB/yZV3jrYLCzl0Oqqq/TVIKqkHGpKXce/h5JtomHm6zBAyclevlOJd1JUbZN
ocEW1bhxjXAled460O4oBtzH3s1IBjuudp2AP8SNjGhHzFj9EonP0iZNSMZBg9DnUeCXpoOdJ9Zq
ijcjRt9uVT81bPLVfRJtBu9WVZw+usJEBu3LVlS2bMZox+wowEwJ61DppyjusMbR1OexuZXUFym+
w9OP57H7QkDARQFzo65c+bY1zY3EGxQcjJDtsPNfaw/Pgx1PSUAdHoL2WWDvK01I6jVGNMlYkrzl
Z1D6YaXerYdhjB4K2HP99FqBhYmBRFvu5cZ1QoRlmbhuLQ5kLT7DzbUZ/w9n59HcONJl0f8y60EE
vFnMhgAIeonypQ1CpgTvTQL49XPYq284raoIrTq6qxqiQCDz5Xv33gNtvYe2ZlMXLM2N2oY5D/Qp
L5hDULUUWeYRLww6Z8vyfLLq/cDqVNW1m0SgW50ugJ7uqpag1CJWtRx9FWv8UN87UrTOxmMqusAB
umYq0PmSNT6y25jKOe5ozzL2TeIveT5m8IKq30RFSsptDvZruA+LYWU0v3owj1F3mzSswdOxTp6W
hEjcpfUgL/e0rfXkV1c8p+oa4C9b73rAX2NnrGAR2/uQri2yWiohs4B/tekGoxJw9oSHyILjQjAK
K8D07DgPOXzR/tQYldckRpAPe+DfJ6UWpyxCp0Uw0CQlh4ZMsR7HiJSwv5gTpOriN87lYKq6u7pp
wI6GXrLkQTzWH/3UbCZQZPzSodO6VdgcCiFIxj1THLIU2GvUNmb+pl74EknizT0Y1qpbK+oD6p9V
GcHntA+j8a4q2yK83FfttgvV1cg71PXZvucWmJzcEykwU0CSelDKNQimj4X9raB6WTgraza9PR5i
jQq70WLY0gYEjneJDc4kDXhoT3P0VlFMyyRUWPFm4S6XTQc/d7kZDNkvdf3yAjjxsIk659hjdNKM
T6vt1pll+1DELpyvbT/L4CIdt+G5SetqkyuvU1nDuIMuSwzEUek10EGq30IfVBLTH7tN2zZgFTET
gkiUnF02HDNzuE/NL1O/Dc27rACHs+m7LmgrARRk70TIS5QG8suGkBjXHMAeLAPrO0Lf4pgrhqdD
BilM46hXmdfBnHIqdVPUwGGWIqhg57ZNHnQNdjBD4dWoQPtyKte5a4OKrUoPRuNTwORezQweRqt+
1qBDT4/1/ELNsBll8QoMgh+v7SMlg7cVsrgJ9Fsfcx3IkeGnnAMX8zSN1kpRKecHHkbK8roZb5Mi
dzv1XIrOsw1o93XvQsxxB3PCZiA4EEyBYj3HhbZehvIwlgBm44l4p+bcklYZt8otdPdgFDB2mmyv
aiVnAcuP0n0CBo4en5M7LowntykICTN1jqPVylmoblobxi0wPXnbtFSLGRcouClt5xnZerEmUqXr
23m4aUAh1Vl3TKwSjFO8wQjhSqRf2FzUQp+RAr0i/I4hn73R6uwwEvitcZsXaTk4Jfox3fiVs6C2
xOsoFEWL+tVj9DNDa+VUxbYTWwMCYYM4e3Ko8AmiUY3c14rpLlsEqHRKjWokhGVYjVTyUwZgTpmO
S0/4hmbIbl9+mlZ1oyb7tnrrtNA3bZXNS3jm3G0s4EhqfOoq5OP2vs4AWhWDT5IePSN8blVAtPEq
/BrDBM7g02A6G7kp18SX7zVnx++RK8+xEQcxiNvJ17TJD4kdGrVgLuzf6UhUjlP6GbjCOPLqi2P6
MIge+O+6t24sjQ+Oq68UWC2G4dTUlm+KOxWEa09vtZJt4MfmekrUM8y2Q9MjiGyRsNocHGtPNWOG
Y489R8TIfIouECrsHVSOaQRnO6r8ZLGwq4rtaDdfFtngKwELkRWuO9b1PektK1M9D1XyXujxLdQz
Hxdk2QTJAipMPhQFucjToVRGijviwBVW7aSbyi1Q1nWvVSfH3htI8AnYucCMkMNXqJPtTVjfde1R
RCar40vivBPMVwPGyskZidnSOAElPSYUVnEygbVBOQmb/unSRvDNprUiV17WakdBxoClaKBe1aBe
HqFxYasHGSXuiVH0a5uo8hCQkQHVnfzuAZoWHSeMjUGnBOB8V/UCjnmaD44kfBjna1gRCAXcQYR+
Ew8rM31QotyzVOCVkKcqDpICmJLgFYSy5UPCszpKggLqqGlunFRhQ3ekAHDatmCpzHqy99vp1oEs
TEITFEwjfFrazAVYd1p0x1PlrZxlt07zZTc6RJ9q1WmTt2BPXtCaQ7J3waOvZrs76fPDot2UItwv
veqrNe+jsXfC88KhPI77IHQ4BUeNp/a6C2cmKGM4U+l4qCv9SyeVnpT+prrttbVVniJlRyb0ylF+
qcnTCJ3biVdOf2DdQs3eJscmpa3RDCihgRJdELfzgxSnbhiqblblt/TYqB/qFWPewJydM5zzTTg7
2z6Ljnoh1kakfmZUqOYYH4T1NI8NrTIqBvB7JVKspNUAKyZuiTW2zFg8TCnQnHgnI8XqxpkDOQ0G
ctsIh1ZXmkYCTxGBZwf+TmKZGUr70DxpnDQ6i2GyeBisBT4Nx35r0YJIO44mBtxLln01rXKz9VUQ
UYZduxmrnaorN4kUHwUjYyF7OmZGiUoH/F0ESV5SAQ3M5utkfzl5DOo2g9383pfJI9POG7oihDco
Ozja0QqA7cnW24euDwPkdpwWbu2quqnjczrdXQ6mbkExnPSam4pjXjJgttSjKWbX1nvKs4Vz0T4y
2xMQLDBNb8QiulYJCbuE2G6/pvTqBW8RfSP0uHnMiHxcVjkT4vK1yrGtXzo58V0PTZN2janrVGa5
10Rf0C/oa0Vux7vWEVQ/a28TwkiVlrPpfIRWfG+PPMFw7wcbTjdHlUY7xJnm1SZAm4sFqPXjwggK
x2/5ZJb4qixzJXXWxqhPdPJdha+eKPEgsjdxaa3MfHQdKVmbtN500Lt5zjsBFqC38WhPl4Vnq0Hm
Iq3I6J9DE9SzAcZToiED6jCMToU0biKK1lzjPKFkKJBTCI3511R3LtJ04APnS1tEYR8Ten+fqrDi
TgyzsRERbVb+Tpo3pwv3idwHSsO+o8y3TVz4Vv4lLYFRGGs1BKSqAUmEcL+0gcxTm15ov5MBIHWT
czZWtMWP54U1T9a2jQWWvau8tIg2RT7els5rqYBspBtlGNpqGKnVI/m08NF6nEMdKIbEeimWnWw9
j0h0Iul3Nd/S1pjte8PLfJF8tqp9cOgKZdZp7px1Rk1VigyX96tqvBXhTjDBajeiL4NOX3fYvKTs
mFHJjd1LWm4rmhj64BvyMUz6VY8sVsTvJUHKaWyual6m9sKsXb4mCpaF0+VEGLfWHTIF1DuDl5RQ
JQPDHv01ZNviphDSc0uw5ZCVp5R1usmBJ0DdjBscLQ4s9BQ5Wn0uR3DjiQam9kUsk1dw0kb7fYhG
G3Sctiko4QozWjnTa9EPezm8qROYtuVNFdme1Axe77zpnU5qVnJMGQnKfN5INrn747bXsxvJaKiM
vwp7dPtw9EfA3zDuvGwcvTFK4PqEtCsfQziajh3YzI5NqD6Jle+L9qkuQ9dZqK0qYz/YWGpkOrn9
5RxpHEFs74AW4wtwWwttugkUOkda0hXujE7dyfRDPbGIO+3KjDu/qiZaTQrmB+EWVAUA6+jYIUQF
uNKMPICNgu8FExiVU1v97obyyYou0fTpTTTDjzdYNUx4k03oFbXgrw5enDZurIqDsHlQiuwQzadJ
ze/SZrptJxiG4N9b8Gy6kgRjFdIHwNtfik3GUtVar5aZrRr0LzqPiypThkgJV2PdMJ97nIWKpJwb
3XkySHWhO/GIz9yt4/DYLM5jVoqt3inHXh+PczgFHVJamc62Km1hOLspDcjLX091iWq89K0pXeWj
tGU7VOc25oxJORaNx35+n+7sXtv3ff9LFUhRVE6hQyjWkRrS0q0MHO3SfTzQYmvRoyk0R4xYvZVb
AHtLu7DBk8lgjclGzO2H7NRBoS5eI2M6LfRdoUh+XxlSIIrXJdT3BrOO2QBdAg87ySIcUJj/5cib
q18XALzazCcVLHc5HipCOqZfmgWrNXwwIsC1zm6osz3Zdr/ihZXbEUG7QLtPeUHMZ3sEd6N8NeNz
A59Djy1/kYDo9KEfZ5CxVXEDjHZaWVDkOZQwmvDGkoO68xL39k7E5RvEcZfp4nFuQDdmLYkSsgQF
1eoZ9TLf5SAkWIiyFB284PmafaFLrtUcJEUctJZ7PN9H88GWbqaUr2zTxUXsytFjavmVSZnv9GAK
LjButTI93WiBuSyy27Rngwy3QQJOrFiGu4SnuyZZvmo9qNsalApA3lXHOcNp+7Xg3B87j3J7Z6XV
WWoaHzb9ruzAB2fNuiPWJ9JQQ033DuVq1zi7tlY5m/GE2aNDYBBA5+RVdPcFjYvQUXdyb9HZbKpV
38KVbheY2PopzbaRrRNOpPMAtNVGVc/6corR4ttCeBWQBl/Lmxw59Z0RYWMZyzf74s3NhnXsqAyX
h/Xl34HFrDVmwA3/7BkSXP794nYOq8UHUygLxV7V2NT6pLyce0hL4sIFFMeQbUyv9YseeysT16I1
h56CoVvis6UOK8mI6aUaX1NYkS5EFE1X2K7Z42kxbzHkehljnWwvCpowLaX0pLX3XWUFkwDvi5oj
nOR1NNB/gnGfaJ7MxG2QG7efh3tQLm+1g/+gLd2heA2RMkxfRvtghR8L0F9bsta9UQeNTjuYrI+x
/rTqh8baFc7Intv5rThOcbnuhsTXhhvTltYWf71efnM69kej3g3dEHSO7hH2iofCWVEA7PsBjtSx
adMgml/LeRsb+0It4GUeHPOpkTu/FsoqWmRPomuQyr4NVZ0mnZuYFuESbx3Pfk2LV2F2rTrU4RUN
4xkvhcLIWYmDRGpfgIM/1dBCeR1FQOvrrrB3Ur3JrAgU53Y2ljeZsrOdeoKmMEBG21BswqbZDBLB
nqW8jhO6VMOwDhVjLfMiQNhcDfHnlJVvSVfwhuWeZAq22k97ntxqsp8SjZhJx8ru4f66SoaYXmL4
vaTqkUAYcNMKtfVuFHu2jS0PeNC38rZVWAey8ctklaq6erMoDxHoEpPP33D352SgxRha3mzrb30/
opRLzk5krrSRPdooSdOqaCAtS7kpR7vwLNDN03IGFKS4Du2+aZr9UksOpLacYcYcRJcdbHPZxIm6
DSV5I5c2pzr9ECflWWGK3PddEHImGAt93WTjRh8hjzC2UPJjpD1m83OVfjjpRyreIrYAhWyT7NBr
b5Wg1d7fRMZJmOeRM1tJVnBEJ5KGiSTlfrZ8pN2zMz9nw9eE3aqcT/q4oYePTFC213RQtdjwzQyb
wvEiC2kVEN50rMw7pS25wm2knm26Mo68lfrdJM5Ze4zqk54flfiYKEd5/pjUS573PY+hN9Zg5iXp
TChoydK0yKmbh1jrMzG/xBg7O+s0Gjf5ZQd8aOLsbjY5kDaFnzejy834rKqP1ljXGvLGjh138qfQ
8afEZSWySXCJ703qXYMmfBmT8Rl5jVa7C5IvAgJ3gHDFxSur7bT8dDlezs5tJt20A92j8iiF2t2i
tQeDLS3SGQVuiCVn9BZ0BrZhqv/l1hDbsPgipBQZ02GQPxQp2mgaL5Q4pqkPW3VKHtvJVZUdrYKS
1KhMXHJqur1qBLXmeEU17zj+5/bl+94PlnaSklPX3xg6rnCmvQzTIrqXe5HtysHWfqWLGuAu2ufV
qzo5B22407uJLOZSJo3GeRuq4caANOg545shP/WxsuaktY6cBOIhuKveL/t31vzzEjkbXdKOl3ic
fDjb8XMxIGwfHqXkqWBe1N/btZfW9k6Pdzal+Ua3PiVxb/wq063Udn436wEkYKW4IYyCsYbbBfaI
3DTyo5DAnk57mAvFzVmPRdjw3J60fDwn2cnqYp+A9CBXw19mfI5ZEWSDgB9qRAYGHPzsZFVaQbvl
OFOYujvY94OUbyWN84/MD6ohMz0g0/Dlga6kdF9Hn0VUfDhN5S+jc5C1aG+qy0GtGT13neY2Ftpe
Alhz6nAnsX2D5Ttp1ibDR0goCV2A+4wjqV6ma9GD0OntwW9j9ICx5qnjI1xAcoI7Zs57uf9QW7FG
j7hSaX3kNDKMQvZ6Rbqf6k/sV01HL6PmT8r0cRDVvT3cK7Lk/1mG8Z364Uqlo8dR1w4ClULeeVLJ
/P4vtozvrnul+EunomL/47p2t26cY239TBl/HQsmJ4lcGTPXTRlkDhv5h2qN60CwEoSZWtsoK+eW
MGm+or8oFL8z+F0HgkVFo019IbEpaeY2TV5HafQVU2GPZSKr6sGUNW6Uq+vC+W2H030ed7Cymb85
rRdheS/fzSz7y2f55jv5J3vk4+0uKaPuf/5L+W9c/kaeXn7HxmA05WU/+6rVK9XdmAkTyjhfiVyc
ZkZZDMB/9Gxes0XtxXTGpChwDCnekPrAm/983W9Uj9cBUonW2lmo4m9msymNItDsE8f2VZgvfxHV
fRNQDTP3/2qKEjnqpRFaOSmmtOsad1j6IKqpsRmOj8rWSuXVJMEg1LQtJ8Z9Yhi+rj6Hc04ZelM6
zFZG1mE6I0pYneR2vOmLvzg1vv1oVy98PmaLHEfInQq63uBi8apvyB6I6vqQDZ/MoLfNsCn7R9Q+
unmsiVA3SbGQGosYh2yVc4bgJAQV8BAWD6rxQ/vuP5/2Px5Nvo6KZoJDTG3h0XOGlPrnr/q7R/5K
INzYxdB1MgryntHsrP4efpbLLv+/xKqqrax24cJ6IPUrGD4/+rzXgVWWyBRdckwiG1VX1jiGej+7
7pWUz2r1rBFJy8edVS9C1WvQBvnZpa9ef4h4arkMOBHLfi/n62T62Up/nUgVgxMoo3Ge98rH8lx9
/vnDat/odP9fHlWiSpYxWyzHOuosZB6jcUmjpX0yLQmD6/wmKTRKwPDsSJeZNcEgLfNFkR9q/Rcj
CEk66OkuoZqoU7BYqr5lErHOIOU2y2c5EisrptNlOp/ITjAqL3L4NjZ3jioHpvQQRyOCqJ2ymMQP
8zIVyt2ff62LCvxfBIHX6VeWmsaKSsd/n4v7mawS0Y6wGDrxS6ubt6TmV4zD6YeP6NUCMmdGYeYN
j5KV3izt2rKf/vw7fPOqXodKaaU+lIqesNpHhyq9nBX+fN1vVvvrSClTH2qyNrk3o1SxEENhlEIa
SzYE8L8FxP7jjf2X+3+dLjWmsiY3Bu9AqsbuUp7L6iDrD9X42ucOXcaQAfJ21A5ddbDy17K7YVuv
yudGkhC6ZSu6mLSuc7dqPorx1ZHuQ+s5UX+BVzdnGrYQNSChd5eppUTMTkRrp8rXVfNbY04KCdtU
a7bzxyR7MhIPj8DKZmSTOoFCfJjVxG5vHdUhsMStTB9Rfk/Ss6F8OMsvus/uGN8o0+1iXlhst0Xr
nKR2P6WnpEJ2UDUMGV9r+jtm095GpYYuEgVPdEdSlN0uMHar+0mXvbp4GsNdg+/B2UXD9s/f2nde
i+sULRNTWJ8OZBJdsjk4DCJ8YlRDtuY80eg3ET86rhEpEDcqr+YkrNN8d6L4RwGK8nXKVjc5lSRQ
me+n5hiFG/E3i8I3D/l1nJVaRXosoR/YD1/2Q/2XPf27Re06y2pOpMoeG2ww5fhsgBdFCkp7zCU3
To9w/na044Z2PUWKp8zmSpYXCNNMJCLLq7ttnG057Ys+MPKZpiE3m6mGZajHqFpe5KS7cfQStYF5
tsvYIxszUGguT4m5jZZNEWluXCSHmX5yph0K2CyJ9jdn93f36vLf/6Mm6PVclEumUBPsSCAQP0yh
ka9qs7Fjmt3GXDY5MY1L/paY8o1YXr5aFi+wgawoeGJCg7HcJ4akjdn+cC+Ur05TSSeGtiE9cZ8s
ZDD4RfqXQvW7D31VHilSgeO65rpxVLjOSKcDMYn4CTsRwNx1WpMMrqOQB0LLlQ+moz84bVwuemWE
6iS17PIJD5b1Ej6Y739ebf7tUbtc9Ko8ysyok0ZkOpdski71up+cuC7XvaqNTNFVobjcgeVlOf0t
6ePfNrTLRa8MC8VgO44eFtRyThO0Dnp0NEiWjEzC7r2f3Y+rV09PWVBErk376nXwyt8/u+jVi5eS
xiwnNg9b+9JYPl2cn1326sUr2sRy5Io6ERUjYy7nL9kM393lq1dONaJWEqrKEU4bNhYC4CKqXavT
Ai3/W7bhdz/i6u3LVNJhbZS45MozlPg9mucUUL2T/SW56N9KXZ6T6+SiQU5jTVJ61s9ZHKZoXDm5
2Nu0M2f1FpPcD8r0y0+5eh/TXBfmlJH9rBbIzDdOH61/9L1eBxGpjT4Oc6fgqX+KHqSfPdj25av4
jz3F1CsGtjIjAkMJtzT18bT/+dP+20p6uQ1XL6UZRoTHXk4rSbbJEDlRX1Vx6f/54t8sT//EDvzH
p1YdkMIFLuJLt1aM21n74d24eiPrOTXojHOLu249X/Tiqz9/3u+evKtXkgiDRiU/bAYJhyi4J7g+
QzN3bubUD/XlLz/km7fnOhdINTM76lN+CG3Ri66D+YKO6kvrfrbRXAcEaQa8kKgj08FsumRl6opX
ITf88w365gu9DgmKDFvJBpsv1AhJgyP54S9V83fXvXoZbaJai3nmM6uGJz6kNPjzx/0no+f6fMPT
fZ0JpPfCcDJHTHsZT9hMJmCKJm2KDin5wtL0uUQjikd8RR1ejbnxpEnGwrU10VzK6spknJVXqLlu
TNVGAIzNo4mDtNYYehaBWB71cr5M+vexrbqIJS/poFodPzqF7tuzGVQLXVktUMzRo2Hm6kRohOX7
xR0hZTJShdeFQxY0h4NJYN+05Htd7pFq3ndIuxOT+Tl5yIX1xojeVzhlRbT6TEYucV4GSz5t1b71
e/L97NKTFvOQR/PWSfnj4bfBMLV/XJRoHeNMGovbjjz/UL+zVZQJhYrP+5EAO9QF73++zYZ12Vz+
7T5fLU9Y8BWF2lSQPd/jYX8Kp0cDvZGEgLKy76uZ+xO+ilQKVEfbzk6/7rN2N3cmM4yd1c/M5cWm
sI5lSPY++lSd7P3JYVRer0b789KVyKpda2EmUqvgEkEyaX6GDCCSd0gFg0jHsMOfzstNk32m6hvW
BxwODyWDw1LfLMyep2E96ehYloh4Q080hZeg807ER4XviwgjV++6VY5Y2JomfEAbXUnXGdONBVFS
zqDe+IQabYq9NvwacycobBEYMU0SFNrze6W+p5BKJrFN0WUoN32+lhx0N8xsG8Vt6+2kftGmd4U5
PGZdeVNL/X7OGCqNTCox/3da5bZIykI0JplGBqx4mjuU0uPtjGQ+KrgT6cliJodBDY0UKWgJicbS
cNfFDRowfZPHujvN0l3Vo/l8U5R5NXDYrONqnS3Z0wT/O0+eqmXyq3avmetKZlZPnuOgtJ7FH4ri
aQGFLAxxlkhmaHT+ZzUZUchKsqchGB9mdcVrUJsncrBWU70x637VdmcAGm6ZDL6mf+TNwZgNLzVL
VxPKc9k12BTRpPOpxkR7NwERgJraJA7cADEOa3mBbI0npYi7u6mpL+ovzeju5rH3bJwUgyp56DaC
KblFN20VpZ8TsW9JiiuScTuiwo+s3AUrudRgJ+JlK2Gw0k8A9rwcObpjZIAybFfhIxj86AYlyxgh
xboMGH1VDz09bLdK2K1HYZJ06uwUrJ5OOOGpKvzY6jcDs7Y+if0csULWTkFjfvVjuE4SZ1OSranG
2kcZIZ3GoBUxoLUL2TcT1Svz+7nVLhExrikR7dvmp1z9TKzbGSsDTVKXdgjSVAd+XuHa1rDtY8Od
L77DJURM9JI79dleyGRigmKsJPwIknR00v5YM/htJr/QX2bwu0tysIi/GzYchG7pl93Yizgozp0S
/54i3JoKkoQaZbtRuZP+IAuxc7KAjhJz0TAw0Fvwo1dTtGZKZzmm66BBRxbkdKRjH4UiIxcrEWE2
vsiXh8HGENQgG5X1Vck3ppfP7fQs8yQijZoYEoRj6BZhhVSqWHWR5LYzBmiwL4tjrTTxTO5xl8Ru
NmExKVCmLsVaaDsZmYPZx8jZmFrWqH1zTABvVaZhK9w2qbaKLQ1OIjF/Bc7G9pDM05oUKKIH/TS7
zwob4cDvUbNXEGqUbieVhD7QJ5pGvvDRdDXygjT5ziDNAOMOAfgq8Vmd8dpVxTpmmmGnD8V818kI
zCPH5ctAY7VXcQw7JXp7h+eYZmSfPUtFSzKRhhdD3eTCPkeGcz9ae+RbBbLnOtkJMvnraW225nFg
gba6FynHE5jhFU06T64Ja04prUjcYmyCejaPMz/vXyaD93NApkOY+6j9JrHRVWUMWLPu1cZbg7q1
n576qQzkxGL2es5sYjPtDeIgpc/cIYYdeTE/jtmuWm4UtjAlee4GVPHpm2Pqm7o2kRu2G8eS6c6N
qworZ47wU5J56TD83JjFucp4jCdjZaPrl53N7BxDC1xbZ5EYXblj/2grqDfR2HtVFv+W03wXxfcF
83XepcuGKAwEUNazLkqWyNJf+ug5ZNrVIwsunOJoRq92hBSeB65HPyfgw6xmREM1r6hsP6UoPUoQ
OlW23JqN/FigiZ8L7MVTybqcOq+FxIoYT1kb5JPpmf3ktga9Z6OtfrWjuR3lA6LUGKs62SlYh0kg
Ncu1luz78V1pj0l+VOVftpjWacWuPDGU7C6RuWKv6mz7n3PfbLtaC7L0Dq2hP4flkROAq/O9EbTf
ZvdGTSYzNsDeQV/bMzwKi41iOcdWPY7te8NEPhJuD37B7MkxjGp/trdGO60a67G3X+kteWkyeo35
ZBRfmnk/pr/ghnk6VpKIomMo3y18DAvkHbWzzm16W3ck0Uf3aftUJGveqECEXM3Ik2OUzbcCJlgi
7TJhoaVjBUaDS7aqy8QFIx6qpizt8ATbu66UXVEgHii61B/Su7Dq92OJTwMtjonMu0G7aVKZcJii
XPoVzndyVqLDRcASxQ/Rcs/H8GRER7I9vmtjeGjls6Q/iiTo6QljpZoSsc2lnRXSE3aOGSOkGhH7
JYaomK2PoWLHGX9XePOSOV8Xw3ToLaxuDu9v8xI6ynaKmbJ2KDslHtZclvHLhCuDId0FaSslE6Ww
oFC7M4a/JugZ3xWXV0ecqo+HrI5HeqIjyr4cfzjxSc05VodNJzVewrKFJ3cjtKCpl4Ot/GrtT9Si
KzU3PasaV/GCSxHLUo0eYkoNvMs30GRWCwYCsWC1lPxGH/YI8JLpnNa5XxPObma3Q4m9M1X33UV1
V1PKMRTrdfzjVu3m5UOmnHsiApZeeHal+XI4e5zqPgvsmk62rJOI8Aja6/MZtPi6wvKYbAWOqqS/
NdD7aDMgBPlxJMTQwnaRhsc8/kB0atTjTph3KSt6Kko/4tRlD9YxzdBu0fcOqUGwetGRrzKAggKT
cbcjq0pZFU2C+XrdYk4XzHFb5DO8OEv7ujR7UqeoGTD2WtWzLBESTdPtEtg6SAejie56XvEZzfzU
rZ3m6BintvX65KxWy0ZOt3M1uB2+pzBCfytVG02NXGRc7KC7sA7CfKuKzjXN2Ft48Q0L5SO2BFtH
xqzUvm7flCxfcjOs1L5ivUMcieVGe9OHO1HcxTi16FdWl6Zucq6RlJEt4bTOOsko1exAMnF0afIh
yU+L9MriinZReBo1Rj3ezSkTxWgth8eFbaZt7u3F9iI1kKaVuLO6YzMtq/AylZD30XJWywdLuTWy
1gcLvNIZJyfDcbBeOhyM+XZiATApLA3FWf2jIMd5n/G9L8mrTSxDhkG+uw/Fkyyf4+h9bPdJ+hzi
Qk54FgqeP8041dG70+I64sLpQ9UmFzY0uzJLk43JneEPJIIwsm9j/CqThcIXZJg/YNlrC/lhys8V
E2iLjH4kqb5dqFtHVda2Gd6Br/YzZw/0xM7adV0jVFfVQ1/F25JzQoiYuspNNEZ8Pc5MY715qrrX
IrzvkkelcHbYaYjO0x7CaXiR5HqfG6RyWB+LOZ1HKJkwCgCieSWIsI5OzVA96D1gDxnJf1ztQnSS
WsINwFecSNE9Uii3w1A5yiyX87kqQngp02oMTzOcyxpNWPMWKnejWq1aLAuOhdNffzSIci0SfKVy
dtDrxzEPhuklzWavGnYE5l2QmhR46JV0lhBFO5a8ilp9hs+74iXDLY7jF8gBL/ubkt4NbMQy377z
iBMKxkwv3tpwrzE/VW9pLFAY+yqS2345GvohGafAth2PrIxe3s+stIX+muIJmJwn3f6tAL8zk8qP
xurO0qPHEltzQiAHaSE9geneECIij1mrM05qESnYAf9RyYk/mOOgUD7CfvbtiQ0T/bTb6hs9DmbR
4PneK4z7cpNTYvecpRXW4QyF2YD9e1qPY/doS91ergAENXHP6dIMNwuFaDV0LzFR0v/L3pks141k
2fZXwmIOFQB3hwPPKnNwO96GPSlS1ARGiRT6vsfXvwWFslJiRUgvy6wGafbMYhASxdsC7sfP2Xtt
x+twK4Vn0sPyzzzFwa3Xtygis3YboM9vZHXvdN4B+vzlgP9dT+g/003mAPCzsKhZ3nogTileDq0D
RQM++c65VtjkQ/9y8ZuAGfHdXTt6TLHadR3g68WCn83hDutPRbU8LGUPAXSeMe5ChLF5MG5c7AW6
OUbmuV08jLSaRDphqZjXiU/tiuvBctzbciZRY/k+veks7/dNf4gope20+hLJdB/7Yo05e+3WWAfk
3cRhO6MvY2BemtNggzUCuMMh6hAMO/txPDaxe6VlhgU1uhACnGyK/K5qt2FwFoMncZvs1rfkWYtn
JKi7S1+KI+S+sylEZDSQOFOP+1m6B92ZpyblemRFckEWD+rJwCDj5yxQzW2AFL6uP/a1v9MZSuB7
8pnKyT+fcn2XJsPectHogYz5+Vn7rzaz5e+/a6nh8eHDwF18mrDg4SAO69efP/BXBcifneHfNNUG
q3cGaVfjye3a9yxmlz5Am9GhYhMgFMgDm6iU3Qx5pPsK2IDd2lljwzrNhnWVjO7BbOaH0P0Se8Gl
53/5+Ytatug/e01vGnL17FUozR3AdalcJZQLi5h3KIvNzx/+qybjzx7/TbNcJm7fVynDr9IUm3Y2
3w/BMbeJpRq+RMZd0FmMsA/WgCa3PQ7sid0UX6b6svplUO1XgcyfvYI3vXRQ3oXDNcg7pOMw40W3
pwznRLVFc3X0Bw9/AnmMxdVI4kCEJ7hhr8psdpn8vC1PiEJH+AOubf7PuuJvecMhlqkoYYR8Co0z
a3g/R7/oxLG7/vlX+RY5rJ0cpwP71Qmb+qoijZa+FQ6+PSKCO46Z2CjyEwUQoRfpOmc+nkefqxSk
u7Ux5+auYEeZQ7mpsHOxF2wlpuIRhX+ac1C86csnEcidcrqdnOUxLPttaDxJtNSFcK+84sNQ9usp
iLZZ9lDNej0k+MbKQ9Oc+9ND3lYbOEAe3lGrvarjeJ2B36hpyVb+tXCPLqspa9q6dM7xyFXVY2J2
NKKgwBC7M2K9YnVvCqwzybzW5RNQjdTH93Vse9jV5ga9RJdpikcM5Ub7GLJQjnhzxiJbztxr32hW
ix+/6kqqiuckpFhMkLSCmkhbPJShe9E648GQaN8XpsXWTc89c4vdU84Y+6rLsDg0k79WNNNsTuyj
yPYxyKqEArposZ1bB1kmK5CCuDmL6X3cFpu6Cw/ac2FSPWmxraLokFTHkmYUoURR8DyPX/IiOJVY
YqoQpTF+P1gmtjhTw7kH2LkgAYBh0vk8R5d1FLEb431iVx2smHsl2wQjXukB419w5u8CZcFl0nzV
mETHp1jaF3nxRRTVPnWnTdotPvhjGd5H9fyUDBQ/Dg47x9pyOFuXETsOhrYmv++TCzu5QFIJBsmP
d970SWTWdjLjW92+euFnaYebcgBfmGlaBDGnkmRV2+Z6zPdGedvqcjOL8svQ5PvWmDndPGl5QnKN
MbQ9z4TYQv7gyCvX8IdWvZNdz9iuB5w5dT/uhsKn1ZKeYw37msUdhOmTywg+TAvSZT8ktFK7xYgI
ylPPMQ0Xfcqsy3C+aKke6yl4r4zHKa5PXv6qQ/ynKtuMotpOKPC7wbuUoTi2gfgUCc7qSBw889Xo
BS5dAqgaBV2uJJL8McbhBIerK3ceJIo8k9exNn8xMfhTbSXnPmeZh3y3qZgOEd1+OdLWx83jhLTw
nOJ8SO+S8GkoPwRjC9EoeJrB30gM9l4CP0Mb4IPalTGgoCixUTUI/93CpH37nBufiTD/xcLxF/ud
86az3PixBcnJ5dyOxofLcOIs/vPFX/zFIMZ5cy4MY2zskBKGkzddto21WSqNpgYZVn2RQ3yWsxC1
OCCiOicdGM4ZxvJWWNvAMdZDCBQl+jLb2W3i0/X07+os22TUxqK0NwV9m5hjj+Ee2q7HjQMJLaJO
Co193RXYhVm+/Tsv5bbJi53T4rbBMfrzd7V8ZX+ynzhv6oMqiXtuf3+gguzpld6NQbgxXIQzIZ7A
+Ve6jr/Yl503tQLs59wGnTSc2uR9Rriyas49zLw/fwt/9ZW/2fS9OefASVV8Ksx9HBB0OU6/+HD+
6pHfbPc6sCJJP3s4jc1F19+xm//igf/qUnqzizueKIZcMx/ogGL0/gwPDXQeEc+5ufn5h/JVTvgn
X+xb3rbSedoks+KLxb9SJi3Znw5NwmMMqCWK34fm2ZS77BnR2pPuLyQKf/E1qzdjuXy2TD0tb6sO
n4VeqnycjIAPfv6W/uJDU29WHTcJw2zu+J4DZZK/fhrtFtst6L3h5edP8FXJ/2ef2ZvFI/Zb9MNK
UM0407LrHqI6ukxK+ckKGE2Q9RixS7bWZ92PtCrSy8z/4NYcL5f8P2yGsKU2XQkuLZj2SUl3wiw+
eU52aHGZMrLc1b21jeP0lHMy+vkrVssN9Gev+M2aVHG6tzrJZ9Lm8XWmprMqC7ZeOxxsZzorsKUZ
VrlqinQDuB7KDzSOvHjwMAhZNLWDfO/Gwzp2PloxSspCHJk2rfwQTWq8LvSnIGY/Su6qBVRCW9Oy
KJ5ItTVxCA+woIIGnJYJ0s1P9o3bbkX4lPjPiSq3+OP25ZQ8FNO4T5Abp9G1YJifExTceR99X64b
7yyPQD/M4yc5ylsCOel9iP/hhbLczt9tT1PihUEFkv9kpQWtnXQ9AuIm7I1J7jf9+n98Hv9P8Fpc
//ERN3//T/78uSinOgrC9s0f/34Rfa6LpvjS/ufya//1z378pb9fPvcY34u3/+aHX+GRvz3z5rl9
/uEP+MqidrrpXuvpFj962n59eF7j8i//X3/42+vXR7mfyte//f656PJ2eTQgmvnv3350ePnb7/Zi
QPmP7x//2w8vnzN+774GbfXy/PLbc/7y233x6Tko/ttvvz437d9+NxzznWR8QEyrqT2LEEluqOH1
jx9Z7zxhSq0hfQghvEXrkRd1G+LQsd4JKS3HcyyH6sJeTpxN0X39kfnOlApcsSVMx1K2kL//43X+
8F3987v7Le+y6yLKW6w/y3Xwz5tGKc/WjqOXB5KoyzzzzXViah2MFRMaQKdDd0afRGyHcfyVtuxr
0tV3T+OYQljadUxbCYE++r8pJofIMpwx8dFjxz721i4c4cQtenx3qLlnQok+Gm1r5WzMKYbQN/cR
sxarHcerSeXRxFRZRdAxS7Nvtg4HQFQsUcfwWTgs301owoQsheyusr6aUigjLndV5nMENQS+22DM
2oe5wSu/s3Nhqk1f2VO5blKreZpVWV/XkwyCU+PMoJZ8NYmbNOrsatWlXd2ycC2jKIWEkkRxM8Cu
7aeY/A6xRiUSI1bGy9OX4yWAIc+Be5nAyBmdidToypf5eQaCrFrFOQXxqph90Bae5O2tzcGbvwx6
qGADxEFxlRhh9BCZloQS0jjdQ2UjuKLHlUd0Tw0SvbpUx2gBmloC7Evm4zREMDKcjOSfbTmraqAl
jekHzonpYjVPwn5cq6Qg/Kvn3ax6S+b32ezOcOyUdC5D0fmkTw8qvCmlMRBfNaf+TuQ5AFEfrC+i
gjalDoqqBNq9NBL70ugT+1MSuCwkmTO6L9/dRN8uzp9cjA73grKV5WjHs2xTiTcreZKNra0nykkx
N97CxbRXngi73c+f5asL4IeLcXkax3WVo13Ltt5646bcd1uva4z11MCVSCJ922A03xStbNDMwWah
xvWpGShHuW1jwMDxr0IRf9y/1dd3KuCcKcsVHqC0N1VCEJc+2MsSqoIKm4t0rMU+amA9zRLmaxc5
9ubn7/nHauSP52OR4Y1zK7KovHm+VooxkWZsMEocy7WcVbtJW6SveQ6/9udP9SZZ+OtzaWnyPLbi
MnPe2isroB1Rw3gF+3wOSoLBLAPeqXdIMAyNtoV5lFOxGPg0kpWjmusiMM3XociiZCfSWJyPcxK6
nEKL/qrqed1n/uy1HgYeIGKAQuBf+iKoIs6u3uyuJyd2afzMxam0m+QmzD1GN07xLRLyf2GTu+pf
67arX3+7eC6b3xhLvjy37C7/BpveopD8yZ4Xvv529px9ip6/3+qW3/m201ninUaNLPgPF6TjWvzo
205nOe9cy3L4e+nxM7lg6/+x04l3ri1dZZquLTwtHQ4Y/9jpxDtTs2egQft6wyr1r+x01tsLUwtQ
CLYppQcxjQvTtX+sicpmtDCUpDc2E1nwXlPsfsyzWt1wvEnpwSuQrOUV8JrWu9c94KX1CFnk3qzV
8DKXKTSBwHTj41y6Gf0VeFmPYjLRABll7B3SphCPsPEwf4mKOb0XRjO6AXwCa7OUQ3isakMb55XO
zBh6TBe971qz+lhbA9Tu2R4BeKjab6oL+F30bIMsDSqm9y406Nzsb5zE7+zNWFXuRxzoBe54eN5g
hvTSaHa7oofk2s8QgWQ0gPJkekEIk90PgHGT0JdbtEQ5+1i9uN8mwJ5gyF2PqNpyzqGt8JBYfMpK
mHBv6JRDETT9z82cQqQZ7ASu+RzjHt8GOdSNTSw6DuMT8dtoXuTEOH+qMhp3TuunzDmHLlqppOkr
Ot0Ds7q2h1i9NdCy3JdmKy9biGZ446tZMcHueukxlvBCuoeEniZEjFQjCsG2MuKDkAitDNOdWDNa
L2Oq08IPHDJZPQ5lgjTQ8ioj2jrjSIRAWccRZUNpE/AsRM8Wpt1aAwmcgU/Yfkm/0Bx8c9xPOk7s
9TSEChCrWyfj3kiLED1d7yEtk7P9oqxQBjtPlgx4AoyUKBSANIarXhexuZ7KwWi2Kk3sAaGNqYN1
lcA537ijMd+3UzyZ1kMDLB6eVpnA0uhnlbR7q5Y20VjppJkrVbZ/TId4bHcMJSEDQe/Phq1to8Yy
3aQ5Zsq0gBGbAdmzWcgqR7O0xW0mx4T+UWTA1v/jmPC/sbyVr/ldW7++tqxv/waL2tKO/+tFbVt1
zy2T4ef0t7Muyl9/WNuWX/1jbaMcl5YllEcN67ngKNlf/1ja1Ds2U3sp0U2C4akmWL6+rWwsh8u/
5kcMfC1XL06ebyubweM5rsmvWRZkH8sCFfAvFPFfC6N/VjS8Huidju3YggWY53zb6EiSrCg7UFa+
HVb+1gBuByuw1uMr/m8PcpBh4aoS1mTdl5O5tHu7Kh/Pstxq64u0DPTAIFNocFhqmLGrU5Tord87
yQcPrBbqX3MomWd6Rvc5KkzjWVXKXKS3IadfiM8IZGZbGUAvDOnem/nkO2sCUPN2F02u86EVnVOs
CglQWvvYh7dGapXhzpfhSJ9d2Pl5pw04iGWFfOcX4uilrvnhg2E/EYoSy3QdIW37TZMpkPOoSuWu
4iBicGpHxoNlddlhTOfwPI0N6yz2YgUOICuCx++uo1/WsnwlPDMZcY7L8UrzDS8V4HcH8JCWhOB9
raYgcNYd4s/LabTKX1gWv1oNvn9/FsFUFocqznGu5Zrqzftj8g2330lQi4DNXQtdAUaO5kTdmIY1
IQxUcZP3J92qKrkxejaS2MhDfHCh0XWMYIbZqaPNyEJVZARTlAOAzjmoz6XRINVL4ilDNJsGArVP
avflDjnIMh/JNWztcGhkC4sT9Zbl9UUHWqtd5BvGgvWEQNinm24p13Y06ruN7id5l0DrfJnKtCo2
8Ck8MYCt1eltNzDlqCsdXtLesr/UxehQ3QXmNB8l992zMDWjndCeMDrDQPQ3VeGSUTFNVfnJm5v0
tcz7kgkFmenVMWOqFW+MaYSPWqeAgC5GR5B7IYtsKOhV93mA9sisnpJ4kNV2btz61XV6wipwtrjo
PmY/qghRaTR8xiD123UxdY65l1WKsMjnar9m7MV+kS4Yg60sbeuD3fS+z1iqs0JyNvriNevsedz3
QwUGP29NeZaVHiPSJopDY6NiK/I2gVn6ySnxnWhcD3Pak8Lg1qiQS1kEnANoE42+qj5JFaTT2vbC
ptn+/AK1fuyXuSarksuq5tiadc00344JjLmgL9S8FC6qE0V5ctOPUL9W2JTYZFPy7CvY8B1v+GkI
E2CjrrjMcujtQ5WUq9QiE/LrC/r/e9DvluSz/+tN6C4tiEP7sa7++it/bD62/U45+Ab4irT+Wj//
Y/NZymohbJN+kNSW5S2Eg2+bj/TYmITL39m2sCRI3P/afKR+tyxI2iWfhYM2R7V/Ze/hF3+8kPRS
7HMlKZ6DTU3xGn9c6ppmSuo0ZXbi15kdPvkhuIxV7plIloweq+y6tOslpsJzIuh4QqUvnA6D1dxB
R+sR9A5RMmE18XwLWnZqg70mk+PjRC8RQJtdPRVDS982A2AYZP74kMUwmYiLvWdlL1Y0fLtNQ0rL
PUm66mzoPSaOQievKdTrUy+T8MNAZDSc4niTu31wntH/AF2djFvNYvDZlhPmhpwMu7JvUPYie7/x
y9Y4L2ONUNbVTbVDTZXtFwcfs0ynPiLX+lSbGOEproOPKT2lKJafhzi/9pLrUD4Ar0cqPPfVVoms
P8wQ1wkOli8lCylZFdF4NZgdc9q6sFtCACz1KZh6+7bTxXyjIZ9+yCckphsOMNmZHXjTnnhT/IJp
4By83iE6Aok8wFa3PZYCrrhCspSPhiaDMIY7XUi0AmXq7GqgpFuvY2w8DMr/4PW2RK6Du6IvyZEZ
IeRJ12RJB1Bj2u58mc8wp3RJJoZRBWm/dUzUXqIqBzh9w7wr+qTddDIIzztFMJfvpGunUZ+tREFE
ZQW/zrUaL3oB0M9PbGvtSzAshYyuaakQ+CVM0mlKP15CPh7syMdfUpvuqctIt9QpnTF8uc2R5I1x
UyJOd7KsBO4mXwyXtx3VCLFdJ783lKEuoC0zXy/a8Yx2R34+2gQoKBEHj8OcLxBuRd8Nd9T7OFJP
FUj5a6NleQZrI86LIERAGUWca9zJKxFUNGiX8uqzH1PhDBNpWomajaMdZv5W1KJ47rIHByplAHyz
vnGMzr4YRDuse6/9wpo+Ie0pO+sqm3zQbE7RXoy8ri24P0TD+WyeqD9gGxc00m7dgHSase+zvU4C
gDwzc/NpCvg+2rF9sGgEPow9H1yfTOajaOb3FFn9ydRZsOiRURvkKJqpswDdpwWSayYTWcW83h0q
RJqqxhNkj/aAAqawd44I5cdSDNVZE06kGtWleTGHuCFEG83QWSt7KyfHv4oLt7ooPTcGv1vFGb6o
eHzK7XHaKyvtrsCeoV7oKV2Q80yPJr8C9460CtKFQSk2lEFM3Vu9TyPqj75S+qr2RiSkbeIVD7kE
WoolaFrlbjahEURxEIw2gmwPuoVRzuUWMYT/PisDrugYqIHd29UuMbz6cytzxr6WM+Omaa33MhD1
wffpjhIo5ObHOi2tg2XC2g7i5GnQLWN05j/rLAW3mwbx7egpCxUsTaIXrp5nL8aX2MxjdwwHpn+i
cftVPOXI+AecUA3n4LMQPjnt3QLM8Ox8nN0w7rbmZHjbaTAsbpE43NFcrk6ZDrzDoGhPK408kPBe
B4K/1KxACf6VIZwbQOZlfZdFUQ86ucjWYZGQwxL1PV5UmaHZkQvJ1fLunRjtosB+TNiOBecSYhcm
Oh+ubTfYBpC40t7nJJk8h/lMfI0gON4bg3pN37rcqTCtTq5d2ndGZNvbIJXn9lxckB0ZPdH/vAV+
8GRETbctC1q3WhrlOXBv5ClJcDdP87QtHecqzGGVuxrmYsotvbKHUeDKIoCG0WmGzByfeT0hlDSM
AdtAUfANFkNy7ttYhcxA6k8ymab3YzPSnc+kvssbRq6r2gxONFFJc+ioSCs2ovM6Awjq5C1RYsPE
6luUvXmYHPM6sOJPWEUkRScCD3tndPJjYOwdJ0OWWdgIZxK9G0tqIWnLYpeFw/mEPB0hT4YXIDci
49Zuk/lKuFOJUICga2D3+JPKrdfX3cpsgxbcc19uw9ryd3051Ic6JRHda4ZHgwBZkk6zdUQ3IDd9
pVYpTcU6iK85T6yUpY2NsJOerAo7P3QOZ4Wuze09ZeeddKOryUJYXqje3jYiyS67xOgxHkTBowm1
eYsj62NTzS22IeVed1ksdrWTb6Pe/5Arfajsod3Xk+0dB+ntHekeTWW3dwhidlaYELk36INGQN8G
hnnSHv+HwGUiEyygPg6mqtgFg3EchfeFxPtrZRPfVFcGPP0xeDY95NXweq3LOKrIQHKIuNCZIumm
dufPbV8tUk7u03ixpXFqXAWOSs4xWZJlZvv4TjL8Dqqayi+1nTyhDgu2EpjJvZHX6L+XZPN2JIdO
BiOSYyvc99JP97NtqKfIidzzpuQEaTh6WslKnvoygDnqIxtEoS0RgPXqiJB5PMSurnbBnFQEFHYX
41RPR5151AhokImfs5xwwOQT0XvR86XlJvEVEQcrz6laa0vaObOQecgTdPJWsyNjIz0be9mZO6cM
LTD0RfjF6/3+vbJEuWeUMpzB0DcvATx9LBq0WYEZ6IPTDOLghPWXPsRP5YZeXRKugQMzKZnR5jQu
100VBSfDbYyzptUL+JsQiY1v+OqWJhaBhl5XXrvSwXbY5hNs9JDgvTYx4UB7zhEcnH+Rua6zq9Cr
HeYpLU6h5U8HIxo4WQ80dDKg2e/NPrTXiuTf3YRVm6jHOepItIrk/N4Lohjtn1s2r9KdmCV7U2Vv
6grevmaf+IScBmKb0cqjh6gco4TREojWddfEbkS4H6bhJS/pYHE2k8GJxK/gIiO4fusY7Rq3w7m2
U7GTmbPHQWLu0tSsDmY7lTttd0sYDL4ejm3JIPlg2bIPqSmy8160/bZrJDEfJqlRNR++hhjnOFtT
GD5g6AnTB0XWJjRsd9+nbkAWwUyp5x5s10O3MJ0cuouJxAtQmTtT6LUoAacnZHglUYedLd/XuE46
17bX1czizSAv3IVxeqHKgbykSRyLHtYuY8VmI4goiRL0ZoW7UGwbAoq78Th7fnnD4EHfdL6T7UYO
gDsnmD4bpnFAurWamfSb43Q9teTLAqUuojNRxhsdB0802sRWjcWFGeWXbkBCWwNLsVUGogAu5LNO
1Y9WMl/0Ol9xslS4jGtgC0ON1pr5RNY+ewkOXiPp8e82WM0ALGkz3WeGPKTg+DETLomG3mfcWBqu
Ohcx98guyqj7jLrzzkI32HbJ8KkyPrYlR3buUZJcCDBQsPVrIMbedDtN6tb16x35SZihG0vs0lie
x13yPvEs0ti8PkN7TcUVFCd3SsuzKL/yphDE2azOmgAlz1Rk9TpuWqxz9IU2MNheauBiGzG05do0
8hLRIgkOApOHpv5eiTw7GLb/uejhtDvHye7QFwI3zFHi0qnNbmvf4fX3J4Grom/5jBmUCm4YFpmQ
/tKQ0jQuRUigmUewxySjMxlY94mh91asEBxylrjyw/YlxH8+ftXpT5mzRRrxwAhrm5jdR5EXd0Wb
vvR18MVPsFvSTw9z5qtlX58RFwD6L0FnIVR048NjWc9llp0bJtmhoqfw7frufJog8FpmdpSBvQtx
reIWBGXdkI14TPniV06iXDK3sKhWis6yI5Jd0D+GAvULwePVwzwFuz6MLgMVsFna0VoXrsPunBLQ
UtFIwRASwH2Oxw1HahLlVNbejEEMpzpA3SaLo1XF45VB1OWjvSybBjET5SejFff9nBOgF1rRucGd
7FLolA1f09jt67q6L1Vkb63FQZdFaj3GaXyZA4Q+Glau9oS6MzjmqvM+lFUOSj0z7C/pHKuP6cIO
KwwEp9mRap8vtWi3VdAUDM9tIOolfRfL42wxhhuVIs3Mw8U4T2enxi7qzWDEq4VYxlVuS7kTlZ4X
GWlP8ZYbl0MdlZsWYzzv7phivc36FhOY0/RXZp+4WPscmObZaF7qWvkURbSzK7wA64SH3dQuPOsE
cuOjFTcDOYX9VWZ11i4EI3DWMwY4Gao2EYlij6ygYL93EzNbUbgQHlvoYtuWtxORMgosQNS6G2Ut
sRUQ+WyfvLf2uYfgnSLbHfgKZzSb5y6Tn4ZmjyPty8KPjmVEMwkVUHRs3OhswnM41S3Rgq0i+Czp
j0m+rExTT9wjXOJ2cC/h6WNtkKS+hHCaLqhJcEMPA+prgac1RXOqu4+J2Ts7Oc4Xjeez4ZlSHPo4
bffNjFWX9KdrtgBY4bN/okVWbNOiGh+lb3GuqIbXvItHTjuBCbrLhx6OhCkDULMagp55QFWPZ0Uo
LsKouaXhFu84RTrczqXkPok+pL1m78gY/GRO7V/1Zut8aCZicn2W0402ZIPOu/2URlgRXBHwvlKh
d54T7JoRJ1KaPeQmscGp53zpLe/OLpJbdsNNHkW4CQx9ACWO08h2zPcp1zkZUZL7OJ3oPQ8Zm64E
gDcPvM7Sq8FLtaS3DigLUOI92wF9IzucjE0SOxQQbhttzWi2PyuO/IserI1iQmFzdWbm/jEnigdr
EktY4JaMnlSZPaKX2WohrWODJ0glHSlBBiEZOtYPtkV8S+qpY1KQ35V65+RUUKthlTqUFpFMGocy
mbI46ycn3M7EaSzRXyxgPvnHKDKmVEXb1tdPPlcfe42TXtSEGWz7yP7c2t0DhdFVl5n+tZ7nG1tF
J5XLJzuu5CbNqX4y8nVc1/epSmLrLLTMR0mu2yqVOXW5a5O2VA/Yw+viofBmbORhaF4IB/UXBW9K
OqNbvrpRNh0bgYgjkh19QIXbXSvVvdDadbmKx3LE2+il7mHKjfhDwWjwQmlA+7oiMowxE2KYuJz0
c57B964d2RN6kSbp0Y7R6BnEcT7OE3BzrJAGXjpEb0Gohk0cIK8tRDBj4cm8Q13P5Xu74x7zs0Z0
XIZjErCAU2BOPcmkYTxFa6QL6jEz0kHuOi/6EMYtTYF5EbDRLEKsr81punQqQf55mefvnUp+xC2a
HYK4yI5VQfwb0kAbBwGlcW70mJMCHI52qItzI5ISUyVxDbot9I0NDWdlJoV5YNWL7nPlxET8msal
N0/surrVhK36srlsmSNAgWA4MfhJe9O1hM+1slVfjIwzXzJPFkgAb7yvGhR/OFqXWYciFgdww0wS
YFw94lszcazNyYGbsb/ihrLl2lyi14LZzZn4Iie6s5SPs71ECrd1yry6Heoi/tg1DgatuSZ0J7Rj
rrIGrIRX4R7kKICUhzN9XeZqKzKsrExy3R3ScfPMjRtj0xZRutOWjpcYPIIfPJtQ26Gmpe+NVnFK
jQbvmWicT3Up9MnqGriLcRHF61CTMSeRUO3V3HAj9kKk5MrNbOMEBmfRtnQnXywhViPfsY0k3xNL
utrgnggKdk1IGphIG0NHM/pUCOcEtFtXblhW2167qLFyv+lPaaScJ2fKzIs6aIk56RVgxgrrQxJg
za4zqznY8LTZjxIfB6oNnkcGzxW9uxsscs/KoPtXSI0KxAvrg/IDsUk9gZs1ZLlKqlwuX6HcIkyj
8itIFMY3IrKLjAplE5m06MjVKApyBNt5bUNCIDxvt4iRWhXeS5cgGRSxG1JvrBfVafdIkY/JSqt5
j5TM3auyLM/CvDMPaN/EU16RCZczpDbzZa4RIAwjRbI2rvMmbD1mFll4NEwyd5ljeZ9JRSr3Xlcb
n8puAvJeANYkBaAMty10lfdJnDl3ViNIwzI8liv0sGSaBsD+TTpJPe2Z9TDWwbXh019guzfAyLj1
vtIjcdDWUN1IuyRVKbLTR69XEREQvr40zTE8K+xG3PpdwCKQWgadS9uThzmy0oe8ci5tGRi8hDEf
5k02QOlMUklJ5y4sYeorGwqFimISN8dSPAoVWhejW2XLXIIJxqrwYxMaRWVdjUIOegszMjlPiq4m
iljCENJ6Kq4DcyxuJS0begIq7Z6GAu3XOopU8GFg3wpWzKGDu9BBwLNWrmFa9JhEYG+FE7SnVGBs
/9cHA1f/ZmNnhJk/a/lfFOkLTf/vlTRff+OPjr8w3yGW0Sa6UUZ68H3+0fC3Hbr6/CXzTCJyFvXa
Pxv+LjpTi3Ez804tbWuBs32bNkvFtFnTkHGZEDOX5Ef/wrDZUm/09NpUltJCaF4I4jnGSG8a/pXG
vB+FEl4DlALD5YyNqXNqb+KkMvrV0FsVkXcl1z7Cn5UZE1bF4axfawrsK2RoWbzYz03E4B1aFgqB
sLVp92jx2AaFt+UBX0RNq6Jt42pnNiEnfk30FoAu9WBaI+eXujzVsvA/xIjdzhgcxLdzn0vSqOWF
cgzvLE2C5mg2xIfUmfHFLsm7tZzpjkbu/2XvPJbkVrIt+y89RxnggDuAaQRCpRbMpJjAKC6htXR8
/VvgfdXGDGZnGuc9KyteMiIg3P2cs/faP+i9jfaetaWma45KfCLxY0A+Qw7MaoNLCLmMHTIslqqI
bhwJOMaN7Mm8k0lFbWZFCDeD1AyFt/eayegphRIz/rDuN4TCMqc/Jo1mzWvz4sNYWV9iku0JRLFT
TttxNNlF4DehdvfW6JtHa6hmeL4aEKuIJCVismi6H6rS1/RBn3tdGO2BFMzwgR0nWnbjLMNhGxsu
VJlkTk4WrbKQEEeFHiVrolsquSdRxOKjFxHwMquOrt7kW/xhhDMqskviJ62uIfQHAS7hhG3Kzfqa
Z3oN7qpMCvqmdG/zscihCc+hIn17Dm+J+qi/YYRHXeoUApQRsBQq4fAWTHA8Ahfw5ROcaE8cDfqh
BiigcP7gk1x03zk55+8eFeR3U+LoUZqbg5S16bC5O/a2bDMBZMX0ObMOwzR8lSixrtg+5cXoRI5B
CYJCOPeddNd49fg9lm12SgeM80nbll/oe/hkq2cWKXCtq9gcDHk59pm8jNPWuAUVoYbT5IcMwKdC
wm2ynSe8ysd+UEC5gZvAItKUkK0QCnM7QkSy/zYMk/0g62X6RbSkcaDT2dIKFdcZYa2cOKDTXHWp
TzD7SNBlmq3sjcVhITTmhBA6fH4RE4sjsdPkFJmcM8hZJLiYefq+bwludQasBF0xXM6V9zECMBLk
GiiSNqt+I8tpb0zJgBTMISRbXytKWYIlHbWr3DSY6kkefINo5CzE6t97LrmLSI85Ezma4RTJntOW
0orCV9yrOXKveLwCuxU2yfbuitlm8s/ofGXaLGEgy+UznQ0RJBVPQ7xofagdWwaNA+FN+dNWWmA0
cOYUwUKfK5hrMznVUXo1UZX42f2Ul/KkQwpes+dMa6+H8jLs+wuyPqOdsgfjohec/ZPMf5SYHQ+M
m5pNj5KAM8DcH4myfbZ6hMWEWW2EUbuPNvEDW9sg866M+IvFbGf+Nlo9zFFnIaVwCU+yvWtrUBdp
71y5UfxRumDK1vgiDmLggGhlS+up4C59AD7n7qekf8gN7ydDdedympBjaSf9rpdiaycwrkyL8pye
w8fat28zZLgIsTOCqKvPOk84FqNlXUvXhKqDIJom+pYWPtDvWJgbmjfy0gqByhWD+kdbNXxtbkjn
wX2PYcnftnPtENcLR7kYyaPtLPMfSTdlP7eT+tnI4Uvhi5t5spbnKKKEhElTPbbwg0bIJy7fAxxA
x/v3U4arZ6RQFo3CYZwFIGazIrI3S8stWVcYmwA0BVOY3CwL7z4dAEkyVpzOTgxSb8yfNKI42CFD
VzPeZIh3W3oYt63sirF0eKX0FK71udxFDv1Tm0AzexD3y2gs98ZieDioo38G/OMXOeXC0SB2+pCb
yjBBi0L7Qzykb6wkn77aoaUum9WkWufxVri1R/+7GqrrZKLruil5A55lrZY8SME9PfZuMjewVGYC
P8vMjvZpwVnebhxSCWWW3vPkCNRFvfjsmHCCKp721d/t3BcdMgrChcgV6vO2fq6NPGTljFl794x8
fOJRa6ZZHp5/niqPjJXZzS1zN7UUzigtgEjxsuyZZFgnmh0cfJeZvNRYiw6sR8VIue/U14jz2B7V
p7MTMc0VtyJDNvQQpC9uRTjR2guPd520BpA8BXrMPvQLIgnrdpePc8hOCD1ozFxxUzd+fUURQhQ4
Q4qHaMSWTFkaEpHHqlePEwT8TMBaaoHXc1Y27Ickdtkt5ilxsLKObvJF6cW9bebB35vwnK4jiZHC
zQnA5r287rL206RPY843lziBbQIQ40ol1zRJ7qqBUKPW5L8Nc1JbMkPkt97EsRuNGFAIu5qBvyF5
YWDqYK4eEJ6LKFX9vkyXQ+/U27bpjY9lGBkXsdlVd3lENJqV6vAO4Yy3SeySDGk7EANR1KsBdpWL
bYqixIYx58RYF3AcaiZ6I2OUcQrMPGf/M9DASBHtdDzaO02TmGlSk+7LAY+CmXYIR63+QnV59LBm
qqINfkzm6FviaXvLCM0g695vD3KlblmLHOmF6tRfEULizrd59HRc3yjPvbMJaCSSy+lPw2w4jylA
jC6z6GpY1VVtjBXLwFAGrtVA5oEV6HH0bqqMLjhP3kNj8KM31C+P5UgZvNDHu4rKkqS7TjD+UWlx
5dqVeVeqIr3w5DwA9OLCiyJqbtOyqO+M3FxjGQrrm+U1ClZTOO7Bj7BupA754P4HvyQIUlhQ4hS+
lH01iOfWWHCdVjUbWpIyCOxQV23sODwOWbcAXKqb+2Zoo0e6etGznrufQ8LOI6YJ8VI1hTdJTTgi
0YT5pikGaEBKPYwz7CuHBf4oXDM5qJ7ECwwJxUnAgw2qOE0pn4z2ouknIhqdDsO8jK/gCXlbMpA1
mYrx16bL6w/uLLv7LJvqS2VVNi9/uZyYrnKIssgAtiUMQK9q+ovWLdsjdykkAxV66IYVy7sKHYDN
tTlfVHQSrtCzYCP0FTQVarlTpZf8ezcJh4abxtVoTU915T6nUbnPW3u6GK0Wb7v0yzt3JJkt6de2
H/G8T9PkT7cM0rxb+J5Plpeg2LLppjsL1R0b/YOhQ1pMCLKOJBxXly3ryqNHN/9yIdBjl1QRA19S
IWUHlMpNPje2Y6BU4PWQh0Qn9SWFHVrY3jB2UmeSdgr90svaSooq6FtwSbxJOcxJVQEhkIT7BFXr
f11a4AnWZCbXnli86dTn8bgz7Hz5Oo12hhRRd6z9XSQfFE4HbBhz9VwU0iE/3vc2KpbdhZTuk+4N
ebTZ3y+Rljabdo7Ne7+x0ELXXcyBk3bv50nF48/RVgXcMm0GBfU4fXDfyG6WoWiOizdPP2urHB9G
JHuXWZMmh9Dw9S7mj38U7tBcMHWOfy6R+icFtbUtoW1ity7UnrKwvzKjST30tuwJwJMcczpbkCqA
yma19IfAdipDHDXoZs4XfWVct7wMBvEB0v2Q5usNTydWQdPOK3bdEs9V5/v7ksmb3PWyhcERGml6
CqVHr7+X9gW5bjdzMrTkxNGRS5H7sUD1y74eM5tQ4kZ8z1Qt+UZV8aHsl+4nLwnYCQeR6z5pUM5w
1PSdC1D8H+eKgrZlL+8lizOh0uq5b2BI8fzVd5PXf0vdMTrN0RxepW6F7EioKmiMSmw4Pg5PtU/q
BvPdzy6c2R3uPJI+ie+NYu+JmJp95ZgnKcwLqUZv61VueIhFt+b1AVBfsivUf0w1tdl9KIfosQHC
par4mg2PakQ4TDZRN4b51eiO9xEzdkCpMxnfyFuYPatdaMHowCR2mMvurvTMgZ4BEdqecZPkHeEu
pejI4zPMvcNBczuZnHkgMO9o7HLoFu4OVWaAreEQ1wt4sm68blOyBIFXwrhiM0GKVP6ou+4TZ5FT
SJrEE+VIhD7fcJ8NpkAbNwfwZmpxYWirDPJpsW7DMQp382DmQezq9GOFOAazno8Fbyn9Y6LGNEha
ZlS9PX+zXZC+ckKf6XGw3XQy56ss1vfZN1acsB+sIGryvVR/8GB42jNRzqbUe5NDB51nJBdunGHC
DX9aaX3RxGgtQoqLraERT8VLE570Gqg6+1EbFNmYX/QZZLR+CtfI3CnaZ2mCvS2my0NCZr2dBU3Z
3AU5KS3jwph5yu0srI8jzb+rqAKyBdV1pPnUfrNiYGcWrXeZrRmnshwDsSB1aAYb5KVLJTMXXkRk
G6JmvE3TV9Oy0uvCMOxbFuSPMFHaxzKV4UH0ggOXpvXqalC6S4VHxLDZ1/MVm8Kx+armmjPCI+kr
IsbaYyJLQPJ8N3Sef6wm50MeC3KSF58RqAuPZdg6DBCKsImDsE1nYjp9YhlHFnJDXVktAKnCGZlC
oCbatFGE4ENCu2xt6HLTYrCMVkMayJj5KxCCb5gse66ykQQu4MgrfDThrefpz56KYUmySLvhhGDI
3rHzG3F8LXXb4U6zgTgVEhDMbFeH0FHbBY3RThrWsm/R0x5nSoGgFX57ZDDw5NjLsC0aYzr6Xb/3
/Dh+yo0s/+JH14nXWy0jnInozBBJTJnpiQESZ/gwjXua+OEDW/24104D44p/uKtH9hvisiNuiTVW
GDHgByIclFb5JJuUnY6EW44qzbFyObGZE+RiiHaT4r8TVnEAPaj3bWY/52m6pshMBP8203BpIFCm
EpVYWDLB3shBw8WnnqE/m910j/Ml3qHGKPcRPEMInfmHMjKYc9ZtEBbhsR07ALRhT4hEWfbwUOqL
ZEoB0UxeHpiiJSdKC7jGxhAflpRozNnhy7PynwRmDhu90kWqkVqMJvRkCA4NCT9A7IRV3jGtbbGN
D+4xLvrqqNMu5KitllM+JPfFUvNiupyYlx3tbH1K50xtkxReRmKkP+bYviNsvehUegcmALsR/b8j
zpFPbW3hrSzsLw0/DW5ZpoKJxeHKL26H8Z+JEpZOhZy42BZcbAbU6GU4Yn/KFEZSVXzJ0rpC5IFi
M59o7ozMiEv1o+qLL4YrRv4KBbIoADYjL9tWVBJZ5wRaXk+Df5N46qM9e99gGiY73RHwk0sFCyPN
NmM6X0/Eem99Zty4iRAbcTqhEAdMZte8lDisoHbxPgTMTebLFW+yH/OGwbLwaoSjBYXEgFpiiZyR
97nSNKpbAloHwVSmHIvL2CT3c5D9fa9yesD9eGMt/WdXMMvwm+lxDkt60J4xBjNgx42PPao0GcRk
VdJt5ejdc3O6PVeBeQ3tlCHOoh3G2NOi5C5zfOfoWn1PW4GIva6BKy282DrGVUXb1dX9sjHV+IkX
4iaJ6MAyy8XluhqrSKRf6NIyYPZcujh9g+cCJ1NadJd5/+z5WRaMYzfdCdpZLHhLGzjrSCCU8KZj
hnlmoxdYkQWwPlFUl1Yx0/yOSb4SXUu5UsN+QQprSDQQaF/NjrFz4+3g5rbBbDR3Y9zdkux+G+UD
tR+bp9cQc+8VRH6H7nSRhMAU3Wn+1cG7HPOUF2BQuyRi9QXegYlbXMe0cfBwxoQGjpOxWTRMvj62
vF1sLgn6D3Tu2Kf0A2OTW6jQazTuMe68+lstIEKKRpfXAy2go2GkP/sq77dpY6YXpJrHgS8XmhUG
v6amzFpRmD/LbKEllJffx3iiwki5VknvGBcW4310/yhzms74bpnkKy9OtWzcKh43ZY0kIKmQ0lYW
ioxELiByldXt8G1z8E/6+TZcTECOE3Zvao3smtP7Wojaj3zmvecNe52F/TVzP4MWSDTuQgNxQzGn
9da2xAe3Dq+nnG27kt/DpjvI1HgoKMSPUNge5NTRgjTzhzYmdV7k+qSL6B7/Htb2gmF83wJ7ip6Z
pv4wiz7bA2uwA9LJEfiN47Rx6rbc2U41Ub2BoEWyEVTdR5VoB0Jg+jgrUN2Y/u4aT3/LGSHKmFFJ
2MNAxEdRMg1swHlb7KSyw4YLfGJebqpivoos99iZ5UXjTCSasxEsehoPOpphgM1Y3MZ4KILMWcp9
UbImCGpeMh2sz7ZllAdHGHdd7H3JtTB40tMomLGN1KsEChBnKv2eVLSG9tKgf46NXW4jJyoZ8U9f
dR6uoh/ivVrccZ4PCX5oOBWJOVwOhBi7ge3Z+phgmd4PY/Q1t/P9FM8I0pzmogURXqeCGDMHrfQc
du7KU0UJYUb3XZKxKXrGZ1RIX+Ap3NGGdoIWVyeY4WFfWEagCZBg+FxsjbS/N/rxmZ7DtGFABI+s
TIqNo+BiuIphvUAess2XLDxkurztR4QW7kddVT9xVbHEuNgJw7i481WZbCPh5nfCV8beBlGJgpRW
ykIqNT1hhIe6O1R1UuxVh5ZNaYv6gZIybvUmInrNTPrrIUfEa2XNP3BcnqO2g5Urvuoi69DgeZRC
DngXmbhH5u008gya5ezRTdDlICBHDVM3mb/gDfo2aIrNeXAfMh8I5ejWTOTmpQ5QDMCb8jk25i7d
ypDB3LYU/V5X7FweHAOkhfN2sdoHr4MWF5tNtKtW7U6e9o85fZQt0KJqp7WCPtynIx1NZmgzgQgb
JPqMNUOj2pAQ+GRM5pfMSdfU+cT+kNv1MyWZH9QDqjg7S2+aynisFudL35ff3XIOIqybW2UzM7N0
MiKjj8Nt7QpAYrb7wzVdrJVrtqwVp/t2Km4VSezBvMoeaVAD9bPKe/xN2MEjEQZ1VhwQoV2UcqQh
qsA6jHwc1vZUbyZnjhDxagsxdyY5h5MiYS8k/CyaWMcOJyWyPOOHE1Yu+H5ZIPijBekiMtooPEDb
saRXEov+YyYcNnibqpvCR9TgrowJ2n0MprsDugDMneN7ZBrHgcYptSLLnS8CJ+qtzYI1elv7vo16
DTtRl67CK+039HONn246noyGniNaKVNZd+GcnVp3+Bp5etqKxX5OXFFtHTu+1SBnWiM+DjNDto5X
bsEqu0a6NtuKbf42Q5h2lJ7J/1em6PpH3mG3IE2CxAF/59OfQsJewZ3SJTqbOXugI4GYlfXGqU+p
btVzPLSXVFjfKJ2nA8zRcR4P6CHvGB0+zZlGxzlGa7c4vJg5N+O70lby3arTi1iOnwZ0vRYBlML/
SBDrF/Sg6rnoW2xN7kIMpskeUznhqW/ilLG1WaJGGrJDZqLZbaRjB51bgv1cDnMP/1s43/reegbR
HR8ZJwVcLQ+ZFNt89Y/H8alekX92TnZzq7/0LRy/IhWfqBPRHsxCEmG7eBtaWFnQRyWBWRzFJmVf
dKr+XrPlBb7I5guPIdYhw113cppJEIXmy6OyJswZY/01XTjkNUV7rweDdnz+wZvse682PkkbXUed
GUQimD1zCdjsW5QEP6AANdfhaHAfhi9eBSPYGwecFV5Ybd0Y3mGcIB5uDa2Ql3vQ9A2nvaSbfjnn
/iWm+qvS8SwM3WQJLWh9xBp4ULnsgYWLKHBTGM0/7rJivcI2RkUsbx2SQDddmN3PQ88oxrE21hB9
qELnrhicuzmN7jjgzbuxMxnSTsuxLORtX9nLppQY3Dpc6WwyMJ6SqS+OHkcJMMiE3/gJZzA5Wffj
gDKgQNNhT3EaDJD5JVwHHi5fs7P4WRB3eJlnNa3k885/iGlGbIdyqm4rs2HyiR/q/1vD/o+1hl3+
v61hjC2gR7ycE69/439tyf5/HG6zWqELyud//F/iAiwG5A94jxXuV4sjKN7j/zrD1H+kg5gcWTZ9
JGW5zJD/OygW/3FWn4EPNtileuWP/mJQvE6Bf/OmYgvDkco/pGyXDonwzlhlg3SaYSiJscBOAjFb
Gahey9bc/3Y9XvHZnqEIV/eZBVjIgp+kmBF750jCfBI2kHYn2rqJNTwo0ZnPjTKZTyRO0z6EczU8
iXQEMyer+pdJhE1nNOlGQIMjAIaZq2t+jDsdUbKXI7uuxVrI8i9yA5GXKj7Emc6Ly0wiNAZHY8ob
nzkSPY4yxypVDXNa7WwxehzXOB99LkLLAs6apM8j05sBODWE8YAqzn9MKuWi6WOxDsK8TC+bzCLR
xuky79YbbH/Yvn1lVofx2fX3MYMLHH4WLKlfOIzfHMg4kkqZV1a6XZDatqV/4y7eo1M+RfLft/MF
/+t3bA+2+Dc/6Azbs8RZZk0dH9REw0ddVzcNpE+FadifoIQC3vXgSvfEKr39+9bn57ffx+/CwrMa
7EnQEnR5eY5/d1hHSTKMNp4NhrgFCqHKn3ZRuvJFQzfcO2OB2FDiVn77Q8+1D78+VWB29FxhK9d3
1ovx21VtTOWEpGOhcgSDsa1Ird9lOVIsvGPiDlASmvLOVdmeIcICXbuvDrN26iDnKb58+6s4L7HA
vFTAtASvvrB4mX128ZdfpStKOUXFTLqrqhBPj0Msr6UtBERYe6Y6xqs/UnJ1jo+EPZrmwOHgeN0k
qUyOEZFMxd7sB/MKAUgfbuyw1R8TpggPDjyLe4Mpu76oW2vVpGYRxxzH0IY+OOmAM6BpVd8Q5WHA
Eh7wCoPUruRzvjjdN0SDHXhYZkgcB1z5bV1t0PcXFm4su3WQVDKp1Q8UUla5BUsGrcSVBNVUlez8
jTvmqL582aVfkFGYTfD2JXuJQfr3iimQRLaHScw2PVbF328eQKhowc5tbIraG3D/qeZZh4b+VuNH
eOfptP54PLk76DM9z1pzO/3zHFcGlJ2CHmhsBgUVtfbRQTOhH/or26iTu7Q3Gdq4cFE7lDtgWgn0
wbvW3nNGW+gsVWVOfIExXEkbezbH+5SDOcMaME793xE4/70qEPk9DzKOLwDCvbwqnptxukNgskVY
Oh2K1M9GIgcoC1kw64fcAQvwnvf8bMlYH11HSIRMYLaVBQTr5UcO+BGbXo+wU3jHHmTuev8MYtL2
7WSv4zZdt9SMRWrMzaYxY3wT2vZNrJ2IJ3eJ7IavNrCYpz63oVMwa9KnZknWVnqZZbgMZDE+cW4e
OGQmYycObz9EZ/var+9O6KOvTAUA31JnzAWz4RVYHG7sVKePqCwzdgFUQcU7K80rz88qsPBsKcGF
/SvC+m2h0SOzSITBLDQOOWI9x/6dr8VjX9XlvW69CdMeqP63f9oZGu3Xo8Dr4bG6gfDyxAorfPGC
RK5tiIGOEg0zS22WUC/pQfoNoVjg0OrPTq0ZUU4dmqiN68z5eOg06g80S3b64e3v8spllgCbVmqi
QnCGS/3FV3H0uHC+qOgq2XyY6m18CMkQvvckvvoxaPR9hHYAFc/jGQsMD9KTODuyBT8iiWkVqqdp
iLexHbqIVyLH+TJOc34KRe2QjuHNBQtiEX+vqe1vqhxT2mbwwnkTubH4q8CCf++GyyHORbSC/f8X
/eP3R6AaMju2e/p7edzTUMG3xGkn+vtPURa6bCksjorsay8vNN5b4t/91thEqdXfuYSibPCU2h/f
vp0cUl/u1tLmRacXYiIf5Ph59sa7Xq8sup3GxrLjYm+oLjvg4iuOoGqWm1ll0RF6o9guhRue3v7k
V14kjqCmovYFyMKy//L3iWRG3818kokMNp9LoltoVzJ1vTaVMj65eoKBPlGJ3b/9sWcBCb/unnJW
CJ4EEYS26Xx7jhpzcLx1s5mYTiRGmQdtSp81yVT6YLBtHuu2jw4d46WT49bU3qk1HDNLzQHkrf7C
yid9LSNA9b3XLeM7y8vZ6XBdxXit1iME/VAIpGeHtgG3G4dzJoiG2xJGodRwjyNIkrPkL+OVB6Kn
3b99QV57AtgH19WMo9sf28xc0hrCKBZtWVwLFArdculMRvWNGJ2cNqXdBYnt2te68/Sntz/5tSdA
rXWNoPkrWFNePgGj3eCTSZGd504riCe0eQrraSSOw2Hegn4r3MVeOjz89afy1IHBM10OpyhmX37q
LKJ2zOeBPc4sEuBjDQP7sWisHaKGgRrbSnAHzONSHN7+XOeVJe1fsIvimLpWgC8/uJ3bYhoUVNGE
fcrjoau6I6ldwjooVTYXUVlhzI6UWRu7nmPYRT2k9nhhF4PxU/ca6T+ItSU6NqNp/sRIlUZHIGU0
JxhWizXFCnol4He9fEsKe0EMMzR0E2U01hhWclTmO+qxZaKZ7XkfvMhB0dbNnHyOljNIferEGio1
F7gvcTaotrrsMt1JepJJcbQRAOugwcL+JLyZwadgpH2DjsDRB+SYKAmGMqUZiWuAzmbudPCY6WX5
kBTmQc67oZi6dxhL1itvCtUwJCdeZkeC5H15OW3fyAdpMnpAsNdfAribdqmVjzbH2So+DCvVIS0y
M0jGfLoypFMBx8ft5iP0OSIvrU6exvhLQLd/0/SmuB3tiSrznXvOd3hRC0mOtALQlLJ4uQCOvfyO
mghzQE8xrcl1Ipeypm210Yxf3v6UV05tnsu/75lcDpdH++WnOH6LBDZKOXLFNfVGgdM5EJOK6Gb1
ZhLQ6tJX0NJsFXi9N2+TjCjFt7/Ba4/2yjjzLYhX7Ijrn/+2I/YTqD260QbjMsP6ZAndbVNfRO8k
ubx2dqeekry4ACOB75z9UKq4wqR4pqdQS3x8Od1WOpgSzLdT7LUcVh0pSKcTQhBxkKIlTq6ZiV3t
Fv9UJxnT/0K35XMMBAaHyWJu/RUpuNFpbr1zQf5cVEE4OXQ+aNawxpzzm7VvZglCZx7Ock3+QpG9
K2sz/VhXU3SDmtw66Sj9OPememdXPcNHrdsbYmBrPb3zydDHzpa3yYgQe48cG0YTbkSZNvKYo2K/
rRRGezql0bFaiMNj/odlXzXd1yJClN8THHWlJt/fzMY0//jbp4Ov5Kx8T2c9nK/uiN+fDukyE0jK
hvMSHgJSazE4QaF7L/ziLO3p31+uKO1sTP3KAaD18mOysUX8NTDvbEWS7AfYRkHDz0RDSl/7YHTk
xxh6epio/j8vFikh2zYl2yWqCx10iVk5eyz05c6xTHry7djE5japwJLSKD+UDT7LsWmLz29fmnXN
f7lAOFCa1joU6pPgBX75nacM0Vrf0yuYpuqbw44AwsvE/5/IOfu7HI1/rw9F61rZCZiv/tn1iQqn
YjqzzoNDKpRhaUntSHP7qdGmekqqgjOG1Orb2z/w1809/4XeuijQJ/cQM54ftwp6cO1sYlzz4yfX
CbGOhJJVWmQMG3KdLfHOKGILwtTioUxYnBLJujeuKbuw7vC51Rdvf6PXLjnlNJ1Peg28JWfbcIm4
dpiop/Bed+Y+amY6Ugb0EbA2yRy+c7g6C8P6ddFX148D7ssWLM5nr6NNXIPZ+lx0USIhHpgUJBs7
nRuOHj4QyOxYCcPOgtqj8kYTWeYackOMdz3Ovb7dQm6HdgqpNzm4aonnT34eQcLOVdynt35T+jjg
lgJUjJYKccPbV+qVRcxZnxRKHR83kThbbguDgXS2vlDuaE33Y5piEALPhG4PT3/VOgTTEpO7jZgL
dZu3P/qVipcFg6bHrwY6V+7ssxtEBR1cXzhO2h0vEgS7GYnARU8+rjEmxn3v591Vn7GP7xAFhtm1
aU/Lh6wFYfbeV/lzc+OrOPiXWU0FKOSz90Yj657rEaPDAPL9w9Skkg5MhFBslk9ehwhrXDzKB9Pu
dwPMgE+AFAk1zyydPjUTPlFm75zVwhpv8dsX6c99n/4D98Umg5t2+8qS+31dTXRt5ioi7qmLrOXz
MPWp2neVsK6T0eiWA+E8bbQj1no8hb62MYlQcNRPb3+HVy4Ot3ftZjveStY8e5u0EXZ+5yYR3WwH
t6s1lcGso/dqlFfeWQXDlWEFFrf1aXz5S0uP4b8H4nQzAX+r8R+lUJdE6hZMHtX8zt79yk9Sgn2U
1oPrS+WcHSxTiGrmkHOYaQkxoF3bW8nGSVfsy19fOlqeK43UNNmwVzvh77cvc7NEWqCCcOGHzQk/
7AhJI0/eaUe/ti0qsfL7aSQ6FqXay49BbTFqZ1jXO0B/m7ZeJibKY2efkoR4VFIKYnFyM4ECNIdu
vEToOxFCRD/ENEBCg9Tw1Rss2mogBn8WSYRb1VTYM/jHkE2MFUsVEhEzf/z7i0Pbw1b0CGzLPqfV
02GUq9qQ93/28Cn2TDc1s9F3Vrg/awiHZiEpINxvRU9gfRR+O7fmRUP3A+8HhpdBETuh4kMiOuvJ
rmL3ikNt98528Atse7YbYs8EdL7GezjOecnbxJmBS01wOovppNZzY3xEdNgAj4EYELWgBBIATFdg
/LNtlGdj0GfzkjIMtgWCimSBP4YsUmZegT3Bi1DXtIQx+JFzqgz7yvH7srtK+6595+T92iuB4Fbw
/JgmVNKzZwh8GZBcNzQ21WrMi6DTHg1t6t3f33Pmpmw0zI9c21z7Bb/djbhvjUGCKiGNo5PEnzKY
d622f+dTXltLQEvRV/No4f6xqy1RljhTyJGrq4j+bFFrQQ7w7RThZWEl27d/0msf5nEY5fli5geH
5eVPmhdpFm2uAdTERXyVTEl7qjq6Sxjf/HdO/q/dI15x1/ZYUNgWzu4RoLNmKhserQUEJfaPtjvl
feHcv/2D/uzZrEZlz6IPTdOOcc3LH5TF2m3HmdVkTFwww77bkujdM0zuHuauDEBbNe/crz9/F9Ma
XhePjB5B2Xf2VMguaWt7oOiDEVlDpprrW9kbfxf/tp7TCN0hfkD4HIypYM+OqZZVWrQ72MdQh+R7
03AB1RSL5e4sl4jdt6/ha7/IZ1bJqr+6tc8nFYBD2tggz2lLKYea10NAEzXd8s7a9srCT0+PbBFb
rQ+7IKbhxeuU6VgjCipBzIzoL9tcQaOyiuhiUc10HFKAQl2atw9mFqU3BurPDX60EvRZbl3LVA/H
FHYZun3VBFY7fM+m0n+cSdQArbOkz5RUof/Ohvjny8IdRnBFjeisw46zMx+wZTspEM9vuj5ei8WK
KYvbg47I7VB8fvse/Pkc0z/AQOyguaBMPl+IcZDTJbHomXRYTwBoMQDUBkENpY1BdBUCRo+JN/Xy
nZ+4on/PCr6Xn3v2G/0+HOaq4mk2ItqbsrW/pnWdo4VMF0jThfyQ27Y6pM5inNAoq1t/zL4WmQ/c
RxtZtR/7YrUwTNXXty8HV/i1LwaxnH4aw2tGOC+flkJpJs3+ghHFjJv6vtOLAf2uxpiJlbyQKcTs
UeQY4skD9PB6tts2CRXoorZP63tZjyUW+dYwb0pV53KfxkNDpWBHHuJ9bsORG59TR4Ore17XXKqt
0O7GLdo1ZXA49uXOr1Mk4uSGWoCiElhKGw8wrQFuK4s5RXd+m12MPt7KgNHWqgr2bAL85LJYadDP
GZmjNL3Mf/KlUw90y6lul2ka7mlbQZ4qoxaBcmUl3WU/yBp3h6zRlIezPcst31LLbTPxeF8RrlGQ
rTSt81zgIhBmEIroj7ZK83jntxY6xyhcpcAkpNSXdBPRVkP0RkWTLdn0nTA7XmcP/Qk2w8aXV26Y
RTIoUhpRG8P142fXrcH//Q97Z7IcN5J16Vcpq3UjDYBjXPybmBmcg5QoaQMTB2EGHHDMT98fqKwq
MqhmdC1615ZWMstUkRjd4X7vOd9RMGF6kKK+8bWCQeSd2yzXAW1aLT0uMAi4/vuinODPtYbx2IAS
e/SpVxas0iLd2qTck2kFloSgjVTTrHuawyErGPBra8PrXXuZ+4OJkZ7lcrQuC1N8d8G6PCsl8XkP
dmftw6ArQ0giXbctZIGI2tDRp1IwRJEaKhfYVKCa6akSrXxwGgffC3e4DwoboTZ0rtvOZMW6qHuh
/KWRCzffwBIgmhMJOerzHFGBv0Dl7FFwoQXEbimSyBe9yOqWWhxFYhvVcXbIydv4ppBufBvG/FZU
bXJWxw7OQi/I65cKSM9Tim70IfC16WbKEojzIxSwZ484NAGrVgvLG0svJGpCa6YEijyK6gUKdtfA
NzmOAxwpgZNIhWFzb3StS3naVcZXaiBi2hMy4Al8SAlixjxyU4n7Ph+3JEtkPRpn0khWZjdHG+Wd
NG9cxu6tXjuz+d/wtIeGHIWnRNYW4j0vjO7A8KEmxgBaQ70Perw4cpL9D2VQJyf5V4PNBcv30sbt
EC1zcxjA2teGyPet5eILddFCGzyxOnRAHznB3Qg3xlxkXWhc9LObcZEMenPVjXH2COamv8ost3lM
67FMztyexOIqYzE4FQMQN8qD6q5MEoCbFSxfe0F5FhdSKgbjHNF07a5tp8WQCn+SzAfHGGBS62IK
k7WPKE0uiyBAYT76bYSpugGlseorGfyEyqTxXcwt5CcTeRLRUu98wHi5jLaDht0FJMhk39mdFmIa
8B1JqqLXqnBlDXMa5YDJ87kQGiqSShnQeaXegg0xYN0uqHfJrxnuAcgLlerQlNKxfGzdVAuXkqi1
dilDywP4mIM73wKCdODN9X5Rr4klGPPzWK+YVCrfmPKd1sHdYBCO4iGtVUkvyRgFMfO02GcBWfcr
JaL73mjZby5a0wZH6Daq3wtavi6ZGRGIsqTP45fSN3rMq7oWfHOKsLwoRkIpkU8F/g+9LDCPlF7G
c5uofy8ocvUull5Uw4xf3bCXut/m1xo2dGupoVW+14WYvrVzmaKtcTrAM5mxoGNjZvC7mqn5irdF
wCjCano9GfbYLYLJNr+7XRTcxEzZIEZU3B4oCEy3/hii8SmQjqAUrSYxbtEqzPlwAuPnnqygWPLI
a3ynkVH41wU5m0+NMqIOZ9HUr22ZWA4hOlp/O9Wx/Vh1mbrW+7LGnmJ1+mNftZm70vwemnKiY/5A
Hg3N26vj9Fdb2zoh0LoZsRhT4S0KL4z/GvIPZ8k4trnF0iP8uSwnx1qZtGkOvSeoLhpDR5x2Eit3
j/u5wTYDr+YyaxvglLYFYe+cqIZ8WOlJnN2HMLK9LcUu694wGzCgDnnAB92rokc2bdTUier0fppU
9R/isW3uLLMbpp3uCugEvcvoXqCyah70qAheJ6CcKT2pruCRkIMU4oPh/YCI+qsc7PGhQTeR3jli
yr4xc/vehW6xWQYhLsunxgnSaOe2WoU+sQeph6wr++Jl1ZRvKp2PFfCGuLurdRp1a7asdFmqsQ0B
JFZj4FIRigwAaL3AS6i6lvB1fNojOJNs6C7ioOkvRBNEl1oV6D+VoYZ2EfbZ+AyJOSyWiaT4fObb
SUyOtVU4WMb9yIdimGKtqrO+Po/4aGd73PYgWv3EcFbEKJpXABj4buHdVcbOhA3OzCGC9JqWdlCv
EBshG/Or0gL+ScUyQV/EXLpKzLEvV7gBWA+l8K7xluSmoqOCK/4nB4Ba1jipAvaKUbBcu7WIvvTe
VJtbOB/bOiGzMBNhtA97Btyo1TQ60wDTFDNALE366Rou7pJXcNyF3qRdKQf34VLZVvg0WSSawOru
zSsjQNu2pqVV7lRgo+HRoqJ/siYLW0jKXFnSOvDnRqdeD94aAAJRjLEHvhkEzGzzsILWe3TKIv+a
OdS/LvywnNZpHpMkpuO3+zZNHfiE1rGGAU6apd+aOQg+LGq9iLZNI2hZMjnAtrds1/wRg9mMYNny
4VjgmndvBsOgPTvoAb9PK6oIGmXg6he1BOS5krpWXoejBcEkHuxG35pj3Ye7FvrFtwpXMDKKGJh+
OzpgPJOqHi6ZmvUaP0k8BVdZYZC7bTa5v8rhYM8e3cK6xsSDey/3IVIsQiRyuMikPjmLFBcisfeG
7eWL0G+qYFNZGgY5NxqI8g2Vl7UXAU/uGQRPT0S8id1qTAL3zvcmDCNZnWSgIaoq/8maMDMRQ/iK
F7yz9G5h2L34SX8IoFvEmk9bombEhoJHCMdXonnMvEHrm1js/cS8clTrX2PfaQ4yiKIrZ4J4FEWG
O+4Lxeg1RwH9PxfGcKiL2scx1yXQEYh86LIlpvvxB4s/Nh/SxnG2CvS+xptuxCmoSiLHiL23O3Ub
jpn5Pa10nJHhNKbWKsXBcpUp8t19q8XM2kb6qoXp8StRjvYTwMl4oU9jZM9UIxEvDb6hwUIvYBeY
ca93GyFGY0d0QN+sI1ND9ELPyNy4g59VB0fpA77cxuzCA+Mjwq3chNgFSsZhhidG8773aFayvUyS
IjvPLAuuphe3Y3KOsYPAliTTs3qloixJzwAQWJdtkZd4TdyqtYFoUENbmAgQ6ku7rTDnZgDT83UF
K1WsKlBPzdbUxtbbumYRy/3gkYtGYTAB8K0Fup1s/a4G0pe2MAeIfhq+ZLWW3JU4PAaQSQXpDpnS
LJBIWCy+6KXAWkOwZAcE1EjzZFE1fpiuBztJsV52fvqAUsrCN+SX+lc4T+G9XQ65uccKGe3LwTUm
iJ4y3xAcMLLM5lW5qd2UJZYIvGQH9ayHs9G1/SX+d/KcswGhwcLGG12s+qmLm0UH5qVdK0fhSnCt
ykdUExPCU6Sem6+EP/Bej7bmXqSDbuRrN1O5CwGHVN4F66qW5Uuk+fjpe6wMBnnn3qYcu+C565rQ
3UCICbNlndlmsTNbG6lzQWzOrw5sI+c2c14zMjuu7MDEXejOMgcYQJ75xNdz+Mpgsgdc52N2W4re
plgi8xtpRFFwJs2g/q5jyr5Gvp0G61zvq23Zd6lcuGY+L6ulgfU21BpnXbchPXbaA+rCslq4SbbU
x/yinlotXE96YNRr2Qxy587GJQLBWRRgQbPNaUNwkQtszclTQk7RqsHxddsUG04aGu0qIQEEx3hQ
DMuashx+ZEDaRbUgtHD6ipy+urIRt4sdgChNLhqfWIDblEQguca3HgBFMLqqgtpR5fkCkYM17mwx
8vP/K5ywXIctgp/SZnG1YJFYLcOm06olbRhlnih5/mlTTwPctWj+zeLMo4LRiNyqqPMakY9tRlvM
r+rFTYsZQ0JmyYnd9cdyLptrz5iVXYiVKCW+38PaImA9KxoWjCFt39wIWbZOSfWr0Ewc0Hpuntg1
/0FLZjuYHBzaqq+62aPalKjQFEiLSo7l0K7Vmw7uxaSRiwplYXjGj9jfO3bBpGPk1ZdU8+R1NfrW
urXNblEFU0IEReBja81I59oSukWT+fN9/Z/KHA7iciqqyEOMY5EMYkmdTGaJhjjkLAdg+nNSBR7Z
qfO0m0aigWgLyGefH3V+pu+r3HwcIcvZMyqRuudRMc0N+R7xDnNUUWLnh6vpLdIm8QlyB1utXIcy
tyfaaVkBOjpR9vp4bEpqs2IUHqIgRumoDGqGZL57AD6W9ZSM+zLtvZ3qcvVdmcVP1qHBzZCzNVea
dsr38IdON0d2PXd21yDxco9ehjTLfPKCSA8A9SVR5DfPbWRR0BgjRIPe7NlXmOTctNcfYdzVkJs6
tc/kELw4zhCdqNh/fPDurAQSNMxoddMmfD8UhljzRUm+EFfat3u2P/le6AHBalRBYQyO2Tda5MmJ
5/5x/CGJRZ9DvxbBKiFX7w+q1YafwdXQFiJMBIzueaMwsQ4q7Ti64C+y7efv2R/GH/fb54YTYesJ
Ki5HB9TjdqgkakmlleWmbJIMy/zMGBlYbfJNcwKyrAaLL6XpB9QrU3gELGGsKDr4elVsJsS7e2No
afZZMQg5aEesij8/yT/cFD6DvBjIUmgDHMv++qTzZGQOIYsQ6Sz6lIo5WpuI0BG9Mp4/P9b8VN8P
PGTZ1jzsEMEgHp6LfG86KL2mZ/lQkH3qdmV54RP4pe0AyJJ+LuD8m8vGt8KHdsInuhWR7qcL4KSF
d6Jg/9GLQz0HiwgdTQM9Pmac92eB8s4mz2HWPJBBlO9LcwIUA4jGusuNuj9oVWX8GIIO5FzBZwcU
hTBZWGG/8J41DSLUiQfwh5qrp89iKN3D+YEuaH5Cb+5KLDxNvroaugSdaYUfBvE6Cww5pd5tHpUU
uHPyp8KyAgNVTeMqa0W1qdqg29VJ0n3vqAWuW6mC1edP6+ObMZ8XPSjkUZhejrXXtTn4Ymx4M5Is
x0c9YQl14xG7VOhpu2yqTqkRP06NqF5pPGAqQQFLd/X9fWhImqx4EWmdF733MNKvorndzJgef94S
hCOrawh5CHBsz+xPPIX5l79/NblCJiLaLEyTdN7eH9xpUfrC10H92o8kQlSkhTRd5p549/5wS3nz
GAT4ZmhUfdDdOU4yGbMQESyJdZ+isr6pzcnYqGJSZ17m4PH+/Bl+XN7wfaMjxkBBxExP5/1lQSuA
m2fzgW2rOry2cx0mf1K40DN7deJ1+cOhyIMUmEBnm5sujqb0Ljdro7Ew50RZO62mRiXrAQnNAvjS
cGpi/TiRcAReFta3NKm5sPeXFbrY0bpIZ8kwRPk5bCr5EFk5vMLJLrzLqAsH4Bdaj6XM1/RdP5m/
zC4uV0gu9aUEwrYkNa/cI+sm9K7VpjUVm2DjtJbEqpFCMclQxZ445z/eHqJ20QMjQ6Xf+v6UCRhE
GRoymqhdJS90j7pzo+yNTaxP09nnD/3jjEJ3mmftz0Yy1KjHwb4dFro08wowtExY+XUNCNADyqKa
F5TlUHr5uHQ/zDScctJGCGPC8xhH3c/KjNJmXcNMy5dejjZsJWhfmLcy8kP/xDroVSHxbsChmyBO
HYI6y2EcXUevi2h0FWQ68WQAoZzxIQTWaCx7bB1EEVG5BvagdWO2dYwi6rfNYPrjF/RECgFx6gar
wbVBFqCKIAEOmQzpPbIC8OtKUPUsbl9BFUppV2HWmPWmSwEVAu0naH1hYlQiq6kNip7EbFFftnms
0nWThQNYJMILz7Q20GlCkD0+Xim6FOaJgfL6mTu6dExDcxOcO2CRNvj+VSDnke1qCRGiZpG57bVK
G4jt9tIf1B5EuZo8Mr/W1A/ddAU/IZMbvqnUvtAKjpcYfobxoopLkNklqKo71bqJ+JHRcLgTkO2e
XDeheJj41gT2o+HRL1h9tT+SvDQpMXTWmK2TIY6A+OtxdPf5i/dhEqV+yQbHZ0zyDx2N9xdWhUGW
svqNlprORs+v4X7JeuxPKCQ/LqsQEbBbEzaLeFaRc+D22w8md8qLjaBBHtoG8gIGoT9sVTGqaJXl
Vr0lKkabvox1UMz4+SLfobpT7TJuZbnqJN1NanQ2OQTh0GDWptIRmOvOG5LphLTp493ADIdslp6l
6dO/n//+zXe9L32WfWiTcCfJmZKZdru8iJ31f3vPGehMgx5ur3kkHb1M1ETshMFKESlyQ2riKAiW
pHqQrvP5cT5MuUj4TRfzNDMY9HbnaP7S+O+mysmt66Uk8Cd2oCtRKVmPeVOU2yQcnPNu7hYt1WCp
fW3Hqb35/Aw+rA84A+4nrm3UUPoHlU+vw1StJs7AMkttoyydfBYcaBeNO4Qk3AgSNCFx+luTRuHN
54f+8N3m0D66KHZt6GTpx79/lANt91aPNXqrfTXBsvPUJT1GAOtVadwOQZovPz/eH16deU/szg4r
KAgzlf/tqxMwyosko9jSyFQnd5z8a2z4J56o+/Eos6+bndDs2ZxX5EdHYV/eZFC+lrFDMktKmTqF
A2tRza9ZNUTrRKVE1iktwosDmqjo1hOW0lEiDYNh71TnFNK6a2hn7ZNmGRlMzZFOsUtUVbsDgZM9
CNcZHgMtapkHSkV9XREJO8OMzavMdRt3Y/axS67NVAq16DjTH4M0fI0IsxQSE3E7MMtcQ+sBDesq
Z2tkuyXpoqMEw0Bqj06/v9C0O+BiSfDiZaLqdnhqCCXKwQ36axqzQb6AmGZlq1RDILBqrLyZ1hSe
c2vlpxC0N3zoB7ZffKkI1cJ6vaqlNG/Zk/TlfcmueCR0Lp3Qng8dpDXE2APbFDVkBDfJhqgL+trq
24Q+y1hFobRJTYkiKC6x05bmFnSzz4piEuW1pgVuQ3aNonGlGCy3IcorAW8pC+4Tss9+KgmldKXr
Sa++SxrQZ7YrSVhjLzjVv6eM/89F+SeO3DcDbfWz+fmPl6Ihq/DqZ/7yP//8QrWz/Tm+zc94/Ynf
XBTNFn/pLJlceCBsx2bH/78SNDR7zskQ7iz7M/kRfd40/k1G0cjdwPVD95VMdBa/fNH/jUbRhPUX
P8P6+1+/9L9KzX6/hmRbwkoGUdY8zePF+DAHl07TWZgfzfWUF/p3ldlq005hdd+gtKhPTEHvZ9u/
j2XoFnsQLgsPyPvJYYQQK+IqFWu3cBXRAU5805mutxGp1WJf09q7FG/30q6j6cSe5f209PeROSZ6
6nnrYh5NSxj4qrwzY4L7wgqavg0PUebixEH+eCsF1+exk+BzdvTZzKmFC0CNAi6Ad6cI24BrdZlO
J6bYo1rD39fy5jBHEznYUTVKn8P0dRdftUXoLfqq1u4l2TjxQgbIauliWOOCTRNioYx28TTeRixK
Tnj0/3hTBcsE/sGO+PoteLMYKQo9dojWFmvQ8TCLbfuCmu6pcq75x5fmzVEYQG+/W2jz+sjreWn6
JcS0FWj8S1A5W7oOW4M/idnD4Lk0F5AKl83KuwVHsMwfad/vaYCceSde4eNnDOUHhz7bHx6w77Ne
fn82ABD6PmgLsXZMaW+A2GdXMiaoMUKYtXszj9z8Xry/hdkc316cMwYFRcTTFBhnu/DRoYQK6Y0m
E9F0Nk2h1OSJNsSRfX4UBJ/8nv9sHajfojd3qZryzs4i4ePStc5mVYK/pmdcD1hJoKtE0468hJGI
EFpDcBbhudDHiIX1KMweVqjpBEL+aEKckQTq6V4DcVXXIQ/Yfa9Hi8GLArnVg3xIb1EyVSEoQ8xS
1widU4ohAm75Eiwo6R+6pVCNjJhi1DnerIGESWQbaPYL6ZS3rUD2tETRpAMrTbo0W7paZnqX+cid
OUtSSXpbXI5XXuTe5ujOEhM1z4JQNsRmWloRgeGHg7HpScSyVr3Xjl9cIg6d2eiGGXmwtCbbxfOf
W3TmCh4oOsjkTpjAmou6r5B0eRU7wJUmC/9rQHEsuG5FG/rbdt6Nk9OA6IdgB0i3T3kxWfqi7aXx
fcobVONRJvV0HQYQbRZaLrWvlIoAe0e0nFcQRVSybSwLRWExg5w3KPzIy+DrbW2nyqdlmdgKsUsY
OLhKe8ya9AQD8W2IjD4GTRk3Z0Oe5e0uRLF4mQHFxEZGLsWzRcyKcY1hqq2WPmnTZOR0ASqqKMPi
vabyq13GLIirbe+pblz3TuY9+3oyCFqv/uCdh9rI9fruqIKNJjwCzFM2ND9FIux2XefdNG6I+zHl
Ms1UNS1kXRVrfM6FtpR0P25MWsqkADmjd1MVqrhpeuHe1sB9H23GSLnMCOE5+F0EgKePfJSmcSpk
vAxGZ+pWQhvVr2hgVbyy7diHVjrkNPKkFfX3qT0TPUennxAGRNSd0fhUtbFAopY98f3E9tnT/Pse
W0XDbiEyo/ucpjXkb+plT1oQkpBq5QRSM2BDBEISTfdauiEUXIQ22XfLL1h9tYIq8bKnZ/Urderx
sgri4CnEfHYT5RMbYMxyBJ6bbttd96MsHsZMZ4INZRhex0KgEnNp8d4qH4MF8loFlNiNte5uXuU9
90rGkoyaHv2mqrTaWmC3iR6magiSVU6gxdxP7xEjWUadXTUSK+1iIPL8AiZDnC07QkxvzVZQaCnF
2F8BIhnYtHRxe0fBqSGE29QVEp2U3EQKGEgSs7nl1CMo47uga8g7xxwNghZ3+i3xiq29mJJa0pOk
dB0RHK8RKwP5p7g2kWlPYD5cbadrWU33tY3h4JBXIZ7ZWnT6eekTwqchTPthSlEZW14z77qvOlIP
m4YQUQphmf7D8QugJXobo60pQd8eSD9iXAbSKlEgac7PBjUdjkAYTLDQMiO5LgJJPaausmei4fHl
9BTUB0YZ8NhFwkR5lYQGtykhnfSgmENmLjmPYVn5I4N6KpVzGdi5lS1Rhzffxs7LL6mBN8T38cYc
8gJH23JK6/wFazLqizoRMM9AqFstN0eXfFLwEjg7C8HiuW1YE1F2VpLZu5SACQLYS1mlK7LXRb4m
UXOy1ihdZm6v2bZgfZsMJLqBUANQQCTLH7TXXWYBw+4Q0EQWxRjPq150nW7MAltOjAVbM4YLuy0y
+yKmloSUKOrjceMCXkw3qgppmva2H+vryglsYrY6G32SJhkItzKRxDTH5DcpqNwSxK1ZKtvbB0rW
NfXKqkZI5wy6tbWmqp4As4PU9yfSAJZTiHIrYqMbbQsl9GgZxOyAlxVNnIywlqSeLgGQdDeIHqmz
GqNBKI5ZqGs7bBO5tg3lDrs8CGgqTFKRko0dskp2cE2rfinqbBA7q6RihoSuKdpV6FhYN8GOerzN
6LjubDdGGlmBn+8JuS90Z+vUPUjtonZmE0yOYG5r+uGErLARAcGgM4th0Ydm1KwHr0WNkFcTXyDl
Sp3cH0RQOjlOkDQ3Xuq6/TplT1nt0sbr763UdkGORVl/cGpJkTYKbFOcT2gPySzK0KzyIcByuius
lkWamAb7ZjB7aN3SHQiGiJCcIfks4opmCaE7/ia3ca6SfGkSBZbjmZtWFULJS7wN8gsLzNBae1HX
XeGB0Jx1mCaZt9Z17sCq9GBGrbNGx1CXGnPXLQQqCnZWTxzzwiYotl5DTs0KpOAR4ZmyTBBPOqmh
E1TDcvrBHqrB3VlDP/gHzQm4YVpRVAPsZR15HQyEAI1m0MFGYuTQZJZ8t7uzNo4FG19sUvrCbo1C
LQy/SS6ZVhNIeLVE8YXmbafLcLozkGhHC0Lq7Ts0PHQE68AsWDSOVQ3uR9I3aYbItvkVJkKqC8/r
CPRQqQtJBqG3RHsdEb7ugSdvtm5cU67JDD+yVvO0g82CayO9u3DNh4jrvB5T0/kGgVeOF2DCFVjZ
TpMUfxJLXFSCVBF6ky4U6jpIrd/kiP8XG9XupW7a+uUflz+l+seGMAoAmGXxygp9KuWIXSVqfqND
//2v6t8o0Xmj+O5f1q+bxtv2pR4PL6rN+NHfXMP5//l/+5d/bz3vR8nW86lsi2b+bSGn9XYDCoLy
zSJw/v3vtqzncR0/ci0ffuTvPSuIq78Ie2fhhvmXzdLsSulfVPM//6Q98tdcKcNGwp+zU/nfW1br
L1aO/CTb1tnGTFXtPztWw4AOSs8P1M4rQYrq9L8u/u91MPft/wh5PFIdcIgZsjn3heY1Ex/wo4Ux
ZUDYoch3bkbkk8B8nZSSyfjcZXH/XFWpe2ZUzPrlPDekrDBXicE83beOdW5WrbF+c+v+sEp/3Tr+
Z/k8n83ceYZto1sON/64jmcMcZZHwZTe9BkBR7UmQAzn2deBFd1C04ggyo2igFpr5BvpT81akqm+
ig1/R/Xoh0h6Rpbycgi/nrof+MBv0bpVZ04v9MtmwBhJCOA3tA31iXX/EVnk93mTr8TqiPROnWLy
++0FS/2mdTstudEltrlC35IcQcCgofQVpYr0tqzJpfEmr9kjC/TJfzHCTWCmGSZrG4apCuunNu/U
V5kFV/awB6v4cuLOvt+YvJ6hrdNuwgtLP4FS3fsz7Ep0hkPKGeZGph9I8Op+xeQjgHgk7YB+r32u
exP9OR39udESYVxNboqyP1rYnk9CjFLVtZVb/S1CdnXlFlO5Tdk3U2jsSSfR82IzQMrB4B/q11XT
hhf+gMHT6T3E2YMfnCjd2/Nr+fZFAftkuLBhdZNyM3KtuRr+Zrsctwn0Z03W16lwIJt1ei2sxdja
1sbz8gBpejSQdBhNB0WkpUF8pP5YURK9jpUhwWN0IxYeFqtb8tYSOlmqubKblGViQGjusmIP9wSm
0AuWuQPMo8+0rTbYxc3kRu0LjQwQzVFbuPfSvhOdv4Cy6F0Qi9Bsp8nKCRFs6LQug0mwRpRZeT6M
QkcvLkX24LiVlyyCrroisUn7FmIZerJHQvKWJb4GH2VgVPwIAC2xOmpeeF6VQQoTJadFG3mwXrkd
xcpvYvnNasjYCcIuaPdZbNQn3pf3+2VKbNTYME8D3GD4C18cTQt6alcqVHF5RzucUupkOJvGk9YJ
Rt3x7PPhMEy1bx+jJfLG9sqovGumWG61ZIpITZ9TLlQZsns2vEsUlT94AxEdJCEh9hDh733R3ufc
vM9HiJhHwJtXigIgZl4KMMzFjong8KisZbn9kIjRkYcJ4+a6JbXyirxqd+V4pXeBiypfMonX2x7T
1NLueuPX6JfaBTGS2Xlag08saMzsUag6S9ud71kCiiwe3eYa6n5BFlUlngdAelvT6gl7hBNX1o4i
3iM1do7VWMtQeKW9IB0F7UaTPiDvGi7DYZTXtUf5y40SknGk0m/8rDcO/I99SZVUX/meeSeKJUdV
MZ6+R5mEFjU6CBMF2Cs7683oGkZHBE000D8RKNTH6TLhPuD2XBKpgQDD2Tss/8Mm2cR9eVflzom6
0FF/fD4+z0GAPAEF5UFPPpqspBk3TmOl1iGYyIggnN3l7vZ7J0M6Ts5utuv1IL6DvYfLLXa8hZVS
KrMFkT38d2pYRppdpOQP/Vc1ur9PC13DXHrWPUrN79/WuLHZNapBHMgcwdNmGlcI06yzz9/Do4n6
97XzIZ6rdKA5Xkt4b+79GKVBEItJHEI0jlsHIc3glPVZWzcnBt/7ntl8NbbD0AYnQI/JgNb6/mpM
PfGURY31gI4UPynJmQqzFxkttGqHr7SjhxNfyfkXvhtgr4QPyvMkVs+sr3nOeXNldVR1bWaI5hBa
aq134/WgjGWTO89z+HIdk6GMNeDEMf/wKiPpReSHsnA2f/tHzyyhcgRqupMHtPnkAdZ30egtp7rd
kt356NIVmnxcNpXANhT9MsmT+fxpfrxmRGP0wmGzswBEqfX+mmncWSqy+uHQaxEBIuRY3KYQGhHY
Nf21asxHTsncw5PsTo3hoxncA9TEus7kNiO1wGl/NINbBcmwgEbra6svpiu25MtcM8p9j6IsWRjd
mKPzjycU4igfpzQPHqwo7DYkIla7CtPdTz5H5U0SVKc4u0e+cgQvkBPmfh2rEGzCEEze35K0ixnZ
rIivHaoWt63X2fu86s1lnqvgburVwqHnRvJqKjaZ9M9dBS04Hfpnj1beonKLeAdn2NlEZLoyH7n9
XPHBrGk7fB6knDafP8AjktCszyGpndWxjyTEogt7NEwociWGRkTRdUHbUGGw07oWuPYl2jvcUuWG
is2mn9Wi2SkH/tG7gyYMLx69/FeNuPvatno7XgKCSRMcJuP1HIfoNaOzwyPBY+uxVsqMxNaymvAp
EBfy+SUfzUCvx52prhboFBYB/tEVG1lCg5225rXo43ilVKnWmqvSJUra5sTdPfrmeibsVuQRAL7o
YyE4PRoeLaF/BCg6Kclounbl9tpFQRV2zYsNhD1oKVhZw/fPr+5InYK0FFkaK2F4h3xeQB8dvX9k
cloxZvXpgC6J2mJeeitBECssIFEbOzeb8nXYURMXVeuejcp5CnS8M6VbGHt9ok469Fq3CfLE26Ld
wjL1+ekdtWheT48VOjV8A6jEzHh5PzyIlk5gSWQjRbbmS2mk0zps63hLlJ9/0XbCxkIPA0xv9ehb
gtrzgnqsuoph7azSOOvP4fWU62mwyG7spbP2nDFbOsrw5ohJFX23OpWemVOx9JLYpV7lyKvcTKbL
OrUI8R6sb62H3DEV7bDHXp+cmo3fT0q/Lw6BJd1RNPa8aEeTEt5N4CNhNx2yJHOWvojbc9H36VpO
A1njhKxpmywnpy/xHts8o2UiiY/D8nLLS/TFHAMllpSP26fP7/n7gcZZzftfH9k9ckfBa3G03BB2
1aVtMBqHpEnFs+21xS4qaHkAsyV0OdaG715e1hsj0E+tdD7cD46MQIplFl1oUBtH76KOuLy0i9I4
xIGbbcB6oJiE7njiS/9+QM/XhxgLJRbvOvJ8NI7vX6mgCZ3eAPVzYIrrtrWwHypVEctlIHT9/E6+
H8+/jzTfzLkLhgzpWEAuHLxGlijrg90k4Te7NGiUFP65iWlt0RO0EUc++uDPj3m0WpwPimcABAf6
bJO1+zEi0KskxpTSbg8Je4kNnQDzxqFlQtiO1twlTD7raBz7ry3Kq7WuumbpRbgylUM0tiBIahcX
fbJKE1edmmnmTeh/Fjz/OrF5DKMmdKH4vb/vU48uScmgPWD/YQESm8aP2LTa8yAQ0xkqmeA8SGHf
8k3LaOrJYs+nJaF0gKGroFhB0dTewDEPt/aUmPtMNY9l6L1YhQbLrhi7E3Pxq9b4+HRnjCSdWJ3X
xD96TcyCYA5NyPpQm729map+yBelo4dbt+o2M2BwzyDNt5ZbWxvfa4dD182Y9N6coh9ORKY8v1Od
GcYUXcDmCK/YZTWPdtXkW0rvwXkeyvIFTyLpqHUnlmkVxuc+Zrc1+njy7aXtX0SmB0CzjeVVXeo/
dPB8X5kY6O9ogBivSAHnczf19VWEhf7QNdIje4tU6JYkvL2srGoViYLIzDaPTizKjziMr4+S6YHv
1Tw384odDVTPGchP7qLqIAJaQTRJgl0wVtbeRgS7d+LSvlB65O26vr2xy2l6CHLP/x6M3TdUWznp
yJTcU4cQdcrdxFj66Xg1ala0p2tdPH4+HN4v63+fKSJCzhJwMN+ReTJ4s8pOMItiGtdIeBitZucT
OboUMa72csjInZ/saf358T4OeVbzpNHNEDTmztcgn7fHawj8DO1AHthm6N+IrFuUPoWPOvYpw4Cg
wX9emyeG/McJDVEI8/RsVWFlf4y+y8HOp00dVge4Ys6CRqkJAQGvFMNZP/HJ+sPtRH83KzjRuuAK
PLqdg9Z1DpiC6uDlHi2jJAmvyiTFNB6lxT5rg/S/Ph6eN7RKOtJjjA6++f7xubkTRaxBSqL7fO2+
B1EBLyZ6pdd1a0NL5P+m7kyW40a2LfsvNcc19M2gJgAigr1IihRFTWAiJaHvHe4Avr4WpFtVyaAe
w+7gDd4sLVMpBACHN+fsvfYJCOS7tY/9OEhECJUckwCTHN3fOAox5DKn6qEG94zMQPJT0Jrv3Xx0
w85NElLB6vZ80OWpIKOtjv52etyqDDAF3d9HQk4rb291die3K1xuNQ809Tz3+fzSGd36RTTOjdk7
1oGyrb6nC2XeaH3u7Eunw2abDWrXGRrJhWQYxhX1qaeqOFtbaK+iJHSQBL+ZuLODy98cz/M3OoNj
mADapDdlaRHMiOFpAoryNHlLSJohYYj0xfZWL5o8pDCoziolpksoxycsde8G7Xa7HvX+bbMBoP/o
drshWWolGUlpVo2oIZKcND9J9x0oxNl/+E0eXepoB59MS7MmBnOA36HC16rxa9esOSeH4Elk/Vdz
EcaJYfu79vFm8eCghFuAeiwHh83D+PZl2tIoWrQK1T2jVb+YbV+bkCgE7Ve37Y1Y0feOLC9rdoMi
T2lAosAs0d7odZuBfaozEO+4AkLNX/VzG4gtMo/qoGkkqQbFmu87Zbn3LdSoy96aCT9yEg+jrPi5
nSx2rtRaPZyHFYDL2q4kcPl0E2e/vUAAeupGj86D3NgGkmMB2HDlCODeVTE0orBauqf32ip3ggnx
yiALF0m3PuybGqdAMNufM2kJoPYV6lJ7/vLxy303I20/AN0UbFGdxei4pFApSXm+HMr7WUsILMs0
1/5ZK1vt2a+Lx0XV5eHjCx7VUP7cMlgvGjMGvSJOw2/frd7QA0I2W90jOHSx6yd7i8OuA8I3bJQx
nKVaa980sKPizoYtkfcQjZxsPlUZe7/R484BuNNIczfP9LHkcRqgAw1mSu5useQIh4LsUNoeNHI/
SdZwGn+SCp+dmelG9iDEm0xLh4K65DUlpXMnk8H/nhWnXsf7z5pGHqdY+lUUWdC/v304E8bg0dec
5t5AqfjkeTRLVuXmO8zxxt3HL+KoPfb7RVCQ52y4JSxhlT36rnGyUs7iyHDfjYjFYBWQIL3QaAlT
Z0yRDubg+SZIL3siN2VMXKq5x4Q0XQCi8i8aMj1BBmoWxYSmKA+GQeq9VQFz4R4oxAlyub1tvxdN
peOc4XdtTxnstw3v20kClyLLDUs26FoKc2+flW1oSFYySo62X7thQ0TvnlLnKd38b0b9u8tsR3sT
4SjnuqOaH7PBZkCU7T0cqZ+59M5U7j+1vbVETu4AVHE0EbZZntxZGpmZWjIRoeEYCw77co0qnbza
j9/b3z4gVAkOuQM0GRyOQG/vO1npiuVB095rDafuuqyCXbmYxUXeuQ9sAdfrZvk0FqN26fXrg0nM
x5k8dRbZ7vkfz4Q6DsMUpxYbGcaoedzQSTWkFppo1Z1B6WA3iXWK7VL/VTtesau9cTik+iYebuS0
q6lm1bU8UTw/OgzxA3wLHi/Dl3gtekpHz8Aq0pKGnj7cd0JuZDNV7dqx+EKo7fd07AhMK1A4QIuk
OmsZMvr4DRwNvD8Xx/bEMZhRQcv77QvQK+EUrtuN9zTcfoBHsa+oh9cPH1/EefeMt+3v9oy5SVSt
xwxE1xnk2il3uqe66h8sW6V7aA74YU2OxOFimXjH0WJeGmba7gUeApQZxI5oCEweXNzE94hX1u8u
kLqbxi/mg2WUydcl6NLnFDPYAYxHtjfRHu8ba5n2vhDOPpsggeQEW8Bmm+YzoXx65E36KUkUpdNJ
jpczXLqDZ2RfpVvVB2v2gp2+ZMONC6+UY6bSdkuxBJfrSnRSNkNf8VKveJAzvBV9NCtkMQT4Jb0k
MDlrAa8BULmEITceJDiWq3T/8TM0j44TPj1/nSFPqjgDhjLCNoz+cZyopVGO1myt932Qv1oLgWgg
wPSLqg6g0LX1am7HesSIRW6qQ5Iu3bc0G59hmyQQrcr8pWtrcS27obvzM5Hs0iwb91qXtaEsfPey
a6AeOURIfHKyJYgC6TSxYyYEU6P/Mq8tmZjxOKTV2dqvpyJN341BDDyUcqkFYJCis3M0K1m15tXK
z/R7jg8Cduqs3RGjmtz+5w8QK5RL7472LeeWowfo5roKZihY91M1x+2c71LkmRq1cjcb9r4hPme+
e6bN9iFn2oPKGuIEujXqQ5N+ScdPzcbSs5ZrXyHhDJpdKs6qQTyUOa5NRUwAbiA+trCz1BeHFf/E
RPmXt09h1sBCEeCuQhZ+tEdWi0pXl0zFe/y/5Fy3SJwHv22ACJpkta0WhhtwyMCtEO6DdybQjH+R
Fu213Y926NoUd+TiZ1FXKOggUl2smf8qA687OJMTXPR0tO+kTo/BB3Xwg4ChbM8qhHsKWFPspA6d
TtNUZ20RVCfW7uMKAgN7269xjHSor5jvciOMwlYVXCvtHtTosk+sVtAdJs15lfMtVLHumhTw4MtI
JnpsqckLlbc4NyhBVwggNIdzO994cUsf9kTRoyO02oIG0uzGmC2r+ONBdLSn4bfi32Oh3ho11A6P
6R9e2XojpCHzvgW6Rq25RQnbwXYtNVM7cVT566UoGSIeBg/Et/H2e0eWulaEVpn3Zo1ePpd9dQj6
0d2VDK/7j+/qeP/457a4L5PzNdtn/WirBlPNUKvorHurWIlks1OonUsqqRrplxyBQ+JO83Oi/9LD
YgRfYMaTggX0JBZ5usamwdehF+1/tpv//Zt8wJEUZpGJMS+8vX+7DejfrYN1n2fqF3vprjEP0k3u
KkudciccHRz+XIpFmBdKbYiu1ttLgRID4oEM4R6M86MW6EtYYneNXU1PQ69N5Skb8Labe7Pl8JmB
oFQjJcBqTDP/7fVSu2XEr01wH0xW++JqAaDX1C/jJrdlFfoIH77OCrcCmuLmbE187YfvSB91dTMD
rnU5ctx2S7qzUXM9aToBgmuO7Nug/knnjbTZE1/o+5WH8geNJRrF9CbZF7/9uUrONSXFFVKxlTWx
tprq1TI66wyZEIT3ypzOhyZ3TuyKjreGvBRWOQRjlFw3NP7vGfEf653s5BoY4BHxiZvuOSmx9a4G
gbxfam35NAiEIM00W9+Zlru4bIPh0wqhFsDhKv68rv8OLWf3s/kshp8/BWLO/wEKzq2B+V9nsR+4
kdef/5Rvbn/+j3rTDP6FRWzz91K7RBy0VfD/Ld4M/kV39M9aTuHD2M6i/zeJ3fgXtDKOH1vHmE3/
Ns0AvRXZ//5fuA2haCFXCjj70J9HD3Wk1fxQu/l2v4nWC8UmdkiSulw6hfT4j0ZsJfNGcx16z+3S
XiSzu36CHJGxugdiZ67DdIOoSd51qaUdxDTlZzmr5n80f//5Ddtel97AllF3vK0HnquseoN1LpNt
kA2m9zc4gofLbsEW9I/3cvtn5vivPVx/LrW5Afk8cVq+O9bNtTY6Ug8IVvE6LxZmz7at6UdaECeu
8+65UmRgC7L1QbZN1PHEVYrEV77OPbUzkYoT6RVn6JT6/FBxdLlRXl2gNkr6wgp7sjZFBLDP1c57
b1peHcR81yAVnAfa9/0S0xHr+shnU/NQLsZsnCnZOKgVFMG3YQrOdETpICm1uh7B8jtdQz8WLsrC
3dGXbvdM08jZtR2qhx2eZmvcpZAyfniN6+3GWWH0lkWJ5DvzvVwPzWV2lh14CkCmRup2l0Mj7HU/
aCyt0aQyL9sN+trZF1hpxiw68dTezPa8HaZMVjAqnJTGaOofzfazZVaJx1ISZen86vYzAleplafW
lLfbBdZHtrTMmMhY2Uwx+o+u0oMPMfPN+ealwGm11FZwmWc7WvhYHgNpDdTIHXhdvtbSK0oN45Py
UTflQ23iFhBTDEmUWoePQF5JBtOJofN2id1+Hr0Ctt0brRA5wzEvb7MPVVXHz1tH04+70QWA3GkA
Q/t+0HcQPbWHj5+6ue2P/v8i+/uKW4o0QH6OtpuT8u0cAI3Oya2EhBCTtOpH1IR+EYEnrs/Stupf
09JGR93Ysn7yNisNVpJsfTVTSMo7InKmB5tIx25nGIt8JjtsJf0yQ0IXEoXsOlE12BrE5apbvvsJ
XOtDZ5YLPqRxzIJQ7zp4Vx/fzV8eH9J2boLyAG3I483QtDZ04FciJzK9fiRgThxyO83jSdjXnRn8
+Phi74cSIBQUqFTkfxeljg5KWj401WphLLJLK7lOAD4dap7Bp0ZLrBOl/9/a0aO3RPGF6o+xxauY
ztHWC4p0qbkTnrlGkhRIJDye473kW6dMaGjLWe+7qF2g+WPaXEAa/1ydIbid08WnXNR0hkO4Rqr3
+9nVCv8cyGj5OAazd+sWXuZE0MrRaYKPLAEU2JWVITpfML41maeiVmYEAtpenc+RyqW8JQ2Ywq20
5oxIV9MUWoSuQl8iVUsyFtu0MW+FTbLAJ/6je6fWxXmZna04bwutu2ibgYCCOh2Zs4RLtR3LWNZ2
O3AigQI+3kMD+vg9HZXzfg9xvnm6fEgimZWPYzvdRJXLnIwkUK2BPKzSIJKgxx3xaYAp+2OuAB3j
37KGl6ENkq8j2yf6/4V72ydT+aq5PYeXEaXf7uOf9bae9e9fxUH737/qWKeDqrAHTEdQpp21SR8Z
ZlcPoW/OVHV8oqkfm7YavsIwxMmT2E4xx33vl98//g1HvoM/P4I59zdnB8nFcdwzoO5SVluiadu0
BQkKSyMvwZK3cRqMeaQzAKDpcvo4CPrw8WgbM4kN2rAb3D6JVlyGmGFT6V6AR5weLbez4jzPXeIH
lG2dOtyzVzqeqbZm7f/7rdvH/4+dbjDJ3E9Sfus06j7QbUImLBW0J17LUX9meyQmWyxa0ihbf3Px
3l5mHBaJEw2imqiz5aV3rTx2sm65sZ0sfWxTILjRxCLAIlvNfaRZ2pzHdNGn249fzfvhwc+gu8k6
wE+hd/z2Z3T57KZJ34Jt7BIPYlaj7gF3pecdmP+r2sENZw6NHneYT72o8d3hxPXfT6XsLzl4sVB6
FK+PoYVenzjaZLNZ0rJ12mdj0V85bd9tCJiyAWVtnJIy/e2C2JJQ/Ww4O8Ja397wDL5FWvpIVjHA
0rjBRnoGggaLLSrfcBbeqWrr++FEEinrLOUmjmsIEN5eT/BJZzCs8RhXvYwBKpM7TQf/xIr016tQ
k4Jks1Exj7fY1RwEQ6W4q2wI7LNR6QDwdcM7sYn+61VgvmJ8YvtBFeTtvSgf78CCxzwKAuJgHPz2
MfEVp1xKf7uKR+Fx0wMzbR13qmrcqQDa4fiWvbbGdr8SIMTh9sQH+NeroF1gcYBn+K7O5ZATq/uK
z9zraLOHjrCQ6wvUQh9/X9v383ZFJaWMt0Ing8YCuU9vH5luzjmKX16MKpXat5SM95gV3ENZlO45
n9PyhaDuKTJK8BIfX/nItLLNMCQK8llzZkdMikr37aX5gq0eMyVHnp6/XBdr+yB6bdpX2dLs2jWA
2VuKNVrF1Own+3Wsgocid7bIibw9sel23j8FC0IqBSQOpxse8+1PcWZzxIFA4DwPu/sOjgWXrmV3
wMuX+YTl6veM8faJI9VAkgJt1KZAfzxI3TwdZt2uk7DN1+ALX3swYnKZJNalDg1c5Da58nCE6PqF
M5S5B+avSK5qqyX5wUin7EuRmLlxPuZ1OUazTVRHyBbf0fb1lJVVPA0TYRiVWpwfjWwJf4IBm7D7
xDx12ZC6+zPhbjnXoEQRUdDryOJsjLPpiQ/+/RNFxOQQ5QjADCvQcZ9sHrpMLYkZhKlk296kWPkJ
o5nOVuukN+H9jEmRnk0hcJstKfS4KcVpBNy9IQApwJ/7SVCDuNIEQC9hBr/ajeP/8bh9f2dUnsH+
UdSlhx8cOwADp66tVXG5ZVkB1WodQgohCiMk2lr3TjzGo7rW9pFwU9RaEbdu7hL/aLWvpZfY5UhJ
tzIH4Ba611wIf+wuViyO+2Rt9L2qLO9LXfnm/URo0blO0kBcGk55/vFtv58oUC2YgPEoTlgINsy3
n4gl/VxSQiQKDtPfk5mq8ZDPNBXwupBNBaciWc+rSnd2Rl47J/b97x/5NqNTVdzgMzpSp7fXBg5p
1DUBNSGYODsqVuoGaFj6KNPmUw/8eNrdPklE0IFj0/Ime/ZoUpqSOitHrZiiuphejcbW4sQzTyUP
Ht+Pzb3QxOK9bmJ9Vvm392N4bmf0k+yjAq7CTUoSyJ6AdO0KWXp7YrT+Puv9c7r5bQigH8AAor5F
gfzttYoSQEDd6hAE1loSouIFyWFJLKpdcpnBx7pW6Vhnqz47yBbKLEDGYG2VYVKCDAcQsU+MCgGt
fhXp5RgQnzE0/VUvyoA6v5qld8eE40xx41SOjpxWy59kFTRpuA6ram+BvpTdviLVPD/xZbx/UTw7
9Ds2Hz/Su3f3ZdtdWq9aF2ljLc5mTQviVhrViav87fFtqdM0cqhTbtPL28e3ZNSIQMmKiD5K/zwj
ncV26iut2Ad6aj5Tdkb6oAdy+izGpmUmx71shLwO42uZEgARSRsVj0K4u3OcpNjhMc3ickBWFVZl
ljKDF4FRRYqqxPxpxSLhEJhlClIMZisxwqAa9FOEy3dbe4aEQ6gypR+mZpaUo3sKVC7WvgDYIKri
wQjq4fuoJpLliBi6sEebxXd2zPu5q/OHJJP9FVgp60S9/v3b40PjA+P6wBH5rN8+VkwJnqwANpFk
J6t9niQUT/I1jT+es/5yFTaC267GRthsHc9ZqRRFodpGREZPjGFnms65TKS++/gq7+ZoqrW0gZAq
EPNpYI07ep7lKtm0G/MQsY1QT71XB79AzMBx6hP/AcUerjxzbOddAGXjJQE4HDdIbvowmNapOzFg
//JymVZYKxw22QyaYx1xt3gSzFAlsRmh5b9abQdLjksGAHT+AQ1DpMBGQ7707GbZdeZEdqQ71Z55
q0+p+fDxk6Hnw3t8O/tsKD/a9eDJdN7B0Uw3AbMUaVrjeDWLkWI6UWoUb4gnMPZzpZx8xzbLv7Ma
8CFkRvnqGY8v9nHg1NpzDQHnUcCXfCJzq/hclwshc0CRHivEGhV2NTv/3i2dv4QUt0intobFuIak
YrUhGw+AXTNC1Qebikd6244EzISq1twW6apV+BeOmp1rIF/WtzI3tF8EJVZ9JE1nqnYBOrgvYiEU
g854452Phghe2WQA6KmlPVu7zF9tP0zr1rIiPNUemg6WFYrPYLJe2BNBvaFGjdjYbMk78igV/MzN
Xn1eC2EnO1tPkV+o3mlJPM1n8VUFtOv3DbLOb70zKhBkuLWRUhAEu3HNBk/ujX5xXntEcSJefEKO
4oKaibtvnEWnINsGlR2L1p/1aHRqoa5mSYL5uV8vzjcnU4TnOW7WfAFoUmb0+V1dXgTEWhMUbyqV
h4UUsNFMmRElVPSB3kDoKoeAbEQOVHGCEO1xbJpFO+RF0d3ThBwekynty3ClTQKhNIPIQwDXVN6U
cy6+oP6Q4Kv9sfzZmUp888ElXbXJmIHO0Sc/i916bV712W12Zr3Uy7mdgjXhayAiJR6KfrgMrCaY
SSVptZ+9IPENFXyzftEKSGuhJVPNPB8dkyJ02VQyCc2x8vO9kO1KWq2tvJfWWee7BW/DnUOgoyIO
zjAl1blp+i6Qb5GJR8xrGlliqL7XDsAXwndWxGNlPa4HORHuyIm7+ZrhHv7mNq3VgPwZYPp1E62T
PTYVkwORqyHry0RuoyUamuKHqu1sJzwrqa/bgdRPNNOmO1FBTLBbLlNd3wR1P/q7tUFYuNMrAAk3
02TVxByUFQgvjV06IhpPYNMsYLyJaEhG7ld3aWzuzLYnWos8prKJ63HyfmKp12Rkt6aqKVpByQOu
NLlE/9lUPz9VWHE8vvrRsM+k37huOJNbm4dQmEpB0Fy1xOT4GWM4qkWj4eEnbhBNq90MmxfTuqnn
YNieYLPuWmEIPS4cHf6RvuSqjO1mHC81Gu79XqtLb97PdSIeOrBiVM/rIvvaDp3wIoUa41udVIMf
ud7cZ3uywpJr4mYt84rMnexRmiIbvkxSXwABWJ0i9BLm5ohdDGItBXTiY8gERYISNg4hllFWGpwJ
5ewGw6VTqO4xzynkR4Y0LT7M1ezuKi8j/o51bPk5S9+7LDuUVwevUfKhrJsBeEDHXoWfUzfPQhpZ
ilXPG69S3++gdchaO0d86j1XaTZ9nTvfmsNtnYLp5BQkr7qGcGpiJoPyYdIXyC3lgnk97ITfXEnV
oaKtyolCbl7Y5Acutr1MkRh1c4yJNpmfEdoQOOh1crnNZ1sHQOQNk31B7LCpX6DhIsGrLxO+2sqU
DbRM3wKpK8vmPuf1tOeq0xCp8BkH1mXQBF4b4QuUbEYGTMBxP4rgILRSrhtqt0PEjPuXpMrekkNM
obe9XqqZEvWsCqIqtXGqjTgvEv0QGKnhYf/p1BLhjcx+zGm/prvGT9B7ub134TaBdmValFWiBdnp
C5tDj6tSwLqtUtkFMSV3thKlX5uvaWbbXmR1mubHoBSRDZvdNssWzbDXUiezoh70u0+yhjEvdJ2a
ItlPvpd15zoiMyMUvqy7Mx076KMQpg1+uwE/GHqJVVoR8zj5nhYhe1VIygAC6YU8wTpckJ2YsS3K
pt8TWOhusz9hc7u5m8YfObs0svpMRRkWqrfQz+a+1Ptdb6E09tZ++Vk1Xl7tPSEsUCALGVxTarGC
qDHH0jBCmqhxHJVjXLWb2r6ul00jL71mCmFtyDKextJeIdEM2QuMOV9dOQGr3pnwschFjlBUs/OA
vXdYcKJI4mLS27jUpU/q45Svv9bWVZ9nU2MnbqZOGkApoEVgLCs0Ff8gi6n/vOoFAsXeuG43IfaS
yEtvGDl31TrfaY6nOH3ROu+ldjTEZ9T0i2RGj6OVBCbOOwCsYV1ODwhmb2fRPPiSMUODiIDaT3nf
PVd2ec4Oe6fK8qeeF3t6cueO1CPOop9ax71JXBL9BGJs/3cs4hj7Tgstbg4OXuZ+Lvr6aWR1t7vx
cjGSgqzb/EYt8hL64UvhAbIe2uvVeG6nhzKtd771arC1rQ3v3OZvGJd8X4lsl9fWnuXVgzOHrCW3
B4OnSnruarEbzgS3EaZNYqFQZPkCR02wWKJ/mrRKJ/PWyKb7pCEfMOQwN59Rkb2k3sSftYimRvhP
tvKo17dp4hFp2veH3BsfJlnv9ZQPY6rb60RVTLsZb8nz7mzkcUJjx+7ONdqN4YkNxwM2AaowIlPf
9MYbzvTFOwDzwKvn7PoxuE5N55L3f2+Z9aOjQRfB/ULOlolrJL0rXO/cKR/99Npy6iGe2BSHNcvd
JaMM7pL6hX/vwmOfmNQBcPdUPBpdem1nOM2KWa0Ha83Ox9nyUa6pz/VoHJREStbZHlYi6zEZi+/G
AG5QmE5cyY5gb3NPZHAetlWzp6j9ddbMWyOjTpFRw9Zb/TNMkDgIkibqfIcqnxZ73KYbotM5iDb7
bGW4xQvfijUJt7TO1l2vVcQUrbew079KQz1p/VdLGaTuFa+FqH6MCdygeWz4yucrcmt2gcrYFNWf
EjI4COYwzkEkWt/ggwoWIQJU8RVdGCiDUpjjap2jbC1iZeo/WgbQlgr0I7e+KZqkylk+qdR5qvie
wsnN49XVz9LJ6e8VoC8yMdnLkbRrqp3utz9sozxbZglRCZtn3ztb9pWKyUB5JleSPNW8vK3y4ax1
GBVFqkf6Or3w4X9q/aXCQ9q0u8ljiiMJ7X4aFIl9lngtp5LAUVCqpQiNemCnNHtDJNvmWomOtFE9
gexOWtFTxtCxz3XlXKPgOvMhIAKetc78brgqiVDGZ3fVO3ZLkDnCy8rSbtyiXFmwLRpO+XwGA1Ac
srH8gZ2AnBACtwuzflC+8ewNRK6P43fMc6QLjl3n6ecqncuEerCtJ+QstslVWTvzF5c8529QCo0f
NThRstBJ/pw4RJrYLOuxoD1bGWlwR8Qn0CWHQwkbSXZZQSzGpQfqkdHeG0VmthHiyMUj4xihXuQO
mIXCbKywHZWmWL8Wa20k0ZIteRNLEkPhFWayvPH83jV2S8/pv7K2tWVEmp1EKB7Ravfm7GmRVZDc
GIHW1A94mm3quh2gfHs08k9J4OQ23IoB2p9wLc3lNbis085C9KNDMCJrpd72diisEcalX8tlCBE1
pGVotDlbHz0xrZRBZPUUNn2jPe8Tjjo7OQOQCsHlLvnOo8/BXyAgcnBwaO7IgJnvbVfJYl+mGQpc
sUEi8HWUHTtKrQM52wMM+pFNRfZN2DJh9Fptf+dJPi9gkahFkdSWiglMaE6kOjTWoeT0fCGauccp
Z61NFXcLQU5RmYmhCGFoJmC+k7Lto7GqEg48Q08CDXHd5b1f4LliJSTJWyN/fkUoDPqotLQunnpX
IsRQk0P2hT2zEXFmY3jtRnvmj9S+ex84fVOHNJtdEIksKGAtlrZEgS47Y9lnmB8JgkcL8mtJIEXx
nAbphGlfoUXvNHwtCGUtp2AhwYQUKbOsN6hzVcjL3lsR5yyGROpZ0XC/6Zliy0hnl+btKN+nl0Ex
5EZsIQUGHqZNzq+i6TUq2f2UPtmSQypRBlX2QtiB0e0IZxy+aMKQV0BCU8GbmRbaNNA6ue111FFz
m2Nx7fk1i7tbCNIPytQjOgdmFSkvylFpv8W31gyeoBtvV5o9/S6fjfWxIhuEeHN4S1+8fmxeHC03
Qd3RNf5uJlnAP056B3htEtflYhn1Odxgso4Nq0KfkQMooDPVTCTxsd2U6UXb18ES+3CVsXeMPfQ2
nN76FY4c4Z+tBfvtKHWD/L4EH0XCdNU+EVoPZdP1uPlFEzxl+jXaVhBThC6Ore6j1DS1TbK0UsJ3
2sZjp1Em5jembzOIEmNlbQdfwwYuXfHI0vsg2xxKU5eeF7XMQZw1low1cBOS0CIXYdNsWtOLbqft
rQ43lk+bCJ3QNYv6i8IOD6+52rpgyB3AFFcJ32NYpY3/tQjQSoTr4tdNVDWdOh8to9r2SDrp7QLd
e2RNuLRip0jyOy0dpyBWBIZVO7Ieik+Ju8G2yXR0rTNnHeTNYEGLDhVJ1y+cNHJ699YqxL6TZXtt
eH3WgwbRspeO/+GrW1qkzeq9b/ZxjzGQMHmwIewiCJAJPZ62uDWSqvm+BhVNETlp5vfWTdprGsOT
gctA87A2svV+1dg630EvXDkbeLXhH+oRLC4nJp8qzIDxfYqTwiR32CdMndRcEmy9cLD1ytoDaBpI
7EX+MILLkDi00g4x2S3tnqGLPQUVA7etDrW9toLPbqqaW/5a+VwZ0KpgNwbLZ2Ki8NgIzpPkzY+9
+GX0xJv3BMs+i8E10t0yFuQ1AcT1OAbh1HJDk9OovC6UyM6GocmqfaovabcbWps9LdHmVGaDYOMr
L0Qxd7ECAT6HsMNJvMM7mT+RoVo9JQFixND2Zv7b0pUDVX+X1CutqkgZtyu2lFqXdj3sM096ZAms
wxJaolZXOZr4coei33QiEntBE1rpzPci2Qic+ynHGg4TXYM0BbvGD+XpuRdLRx+eWsjIgkpS5emR
607ZxVpusMNZU4KgrYIBEKbw9Y24NGv3QETPZTGSgS4HWZDiiKryUuecSpnb8a8BU+cTH64xveYz
ZomwoS9JSnLD3nHUNWhK1aRNoImYSbsI9c/vP10O941qOAT4jUrY25bz9IU9rTbuDHLGFz4WZ2ZZ
yZzsdlma9CHV3fGxBf/HEpZi59xRuGBM9IVg6Q5myh6x0BZP7LPNYgLibA7OGXPlHLr13DnhgEhm
JIzByYyD0/rEUgp0evE8eoaKCjfzR7Jsg/Q286AVRmaxYPKSolxADkqH08gYtHiRVwjul7SHLXtX
1RxH4i6T3rVuF4QRG0bvPfeN2yThRhL9vjCfmXusNvrz5A7rT3OR3UuSJvZ4vs69dy2Um3mhpdIE
SHYemIdqGcRnPGiij0BPMcSSwe2quLC9tD9wjN4KXZZe/DSqyWAwZH2+xIoQDfJA0We8VExc5E9X
rIqxPWMPIqcFKQk7ikkcrEoOeqTGdRph3kwr6ElixMhGh/CbsXg1xR0FAVu/IOnYG2LhEax8IIVt
jcvRTj8Jg6LYztcTtjdgsCD9goutiP/uWb9IV07TW2foGAzuiMA23MiXpFst62SGEP/XFuuAUX2t
xeT8wF83Moi1yWTXDJF9p2mUTGdzzVcI0m77rSiDmtSOWdbRUmlrfzbVS/lqA4i9tuZS3MDeZkyV
7Ipdao2D+k5gQ38t04BaE/mAv9umtlafkiC8rznT0kW7+FuyT27X1kf7hzwnE20OmKwSUe1hHwpT
X41LKLxy+GxTO3wmnU5CIpzH+87L5xt2fPNjN7uWOgxd0FFwpPeWI7ukL05ZRldnI7ml3UGC7v+F
iWW4Ttakcvdlterpfihk/S0ZpGIXXZn5QhC545SRa+J3s4sc7hBwlO5GT/UmCOXQJ9d5ZognzgZp
HjKpV2OUjvN8DYHcRkoEr5AisZLVczFSlzx3Zn2uo6Tp5UvdWetrhQ2KsymrA1VEGTSPVUo5ilfO
tPxx4fhd2ZgkWer1RFRSUkcQe9T1ZKPQaAahpVHets4luuhk5wL650g7nIzjfPfCaE5jNkTJQTSE
Szvk7QvTraHuinwkqEMk+RWFPxGjJD5FhTnyHIPw4QI0FnEmILlGaHo0Lhb0D60HMznyYbeHHSQj
sGzL8MOpTQjoZhZc46DyonXI+Nq61r3u5602W5sg8iF4ztrenTFXlbPRHhZdePg7E229pB6UXVSV
Nx7G2Xc+2+4WXMquJv6PX4i1UUKw1wRoc90jeWzemqPfENXLBnmxEVJnOsnzMAdGZzwlXn2nU+RJ
4V000aTQ98Yte/Ty5zFLksUzm4hFs1FR4iDPZ5yqYNMy5NOv0XPG+UALs+riXM/NS6YSA00nCgE/
mi09/z+cnVeTm0q3hn8RVTSZW0DSaHKyx+MbypGcM7/+PMx3YyHVUPvcucreGwRN91rrTV+RiWgq
YLHUbQDRF9bKoglc7k8DY1krn3D4EoUfR4lrN3l8MxK/dcfwa4MhcmHxE8GEDAB+jGIBk50uyD6O
2oKIj9gli57hE/RTpxzad7zj0w1MX5zDmyS5wLKWMbrBVINP7vRaGjVdCw0FT9Y2z36HsbBv4iK3
GTdUkq5hPJMM0hKiXitOkyfy79rGdPI2I+t5RN6oaaGrE/Y5oXUurTdDxDkOq37d0EhnJmM2Sy7I
HSmzCb+9MNYYO/l1Gv4yozDDUoDs+XJXWFpjHNURspWjT1XyroYpPqVaBFn1Lol8Rh90kbiqmVGJ
r7zpt4uLqx3Lpof1PlF1STW2d2FrVtquTwbzBa/5NnSB1zE5VadckW8QDi0lj0q94bSKTNuJIXLw
tets5e88+Axp0Ey/NVGF7Ynfxc3fJab2Z8ZFuivgs3H08gTdgpvVmfEHZYaIHVu1xsrTKKvst75u
C1gJSksMpC0XOpmaeedXjm4M0Xur5NU7O2b7mFDvTh7+hOlb2LU0+lMRl5lr00Qq+6IBlL2d1YlG
UQk0yMgiZUDt+bneEhSaaum3OkqggRSETcZ0SxRxVwMTCwk6ftgRPjT37bEpLfs3vlLFczCBQOPv
ks/vAMwy5JR2zsVengZ6bLRibKjN2BPR4VOfOJMFpkJyQVm9yUIbviha0UuACzFz7Ko3ROWZYGQE
pIAo4lI9LsLhVGpSXkceiXstzYG38UoZAw+yVhq7hPPkLwkdFp0kbe8tvy7+G5U9nWU7Zb20azot
+it1WXWE0lbTfQdj+BoH6iycZLCCGzywGycpa0b0ta8xxGvtSqsdzKLTn+Q9zC4msv3r53vcOXRK
xQevHL0RxisYyyinH4Nd23Xd2Enh2l08j3sx8atAdAPsrisbKGZpyez9PE0sXosJbrfThC/dKKh/
t+hTK3fF5bgAVUY/A+EGpJyt5vReFEkNa4CW0q3joLybYJTRhTXaWz6CAylk59yUsa0+qDl7Huht
vpPS7FXpRqb0zKauK/Sz3tQ0DFo1vIc+f1DnG9Ryb9wWShWCrNeg7pgXVp4xjHInPRIkcaD+1QmJ
XLT2u8+vtFL7/u8xLMAx/FS4HrChTh8DXK5Yqf2gpHQf2pTojNr8axdYVCE+x3FI7QtPX4YrRWy0
e4P9zW27JHifcUx1ggaU3OnNVr7F1WPadSNWU1YrgzbFjPyLWvG/bNzusl2ewN28NYRqUABUBDZI
a05vd4RKk/LhFi6mZNlVFFetg5NJsx/rRiH6AuU4m1vkxRT7eJb1KBiMqLuOZP/NzgKbFFypfQYg
ChgrqvKd1QSK6swLsFiU5AulI/kcn9/xcpac3TDCF+4aop62ZtGUS5JZO6B8KufC3BdRELiBXfBm
FYOkBznaep8Lr2N1vcUInX6P7wwp6+p9EvbEUFWMqOh1v7+PaZF2haZVuyHT6yN0Mn1fdbP8jLsu
eVeRWXiq2eMV3kzZf+R1833BS9BksdiekYW+OvhkMWWjCWbo6qJr/0hx4yP4GvK9AdZxzMbc2OBh
LW9+9cNhPsNeY+jOr1+7DY2+rIf1xBTL7ur8wdCa/BtGeObtoCXxf64fNHSMcF6gpWi81FWtZkkh
890BgFAOgkJDky+3buJzWDt5ZNv7zxfQeUXEWBFbZvyckOXwUk9XfMKgVw4qPlDZBJeLRhu5k55s
WfiuzI4/9gHUnjoNKqUKtdeKL1QkQ2zFagTba2x93cVi0X+zoEayQff5jLgwUQUpR5oxNo9i7qLR
ETokJietJDixZjJKdOIlcQHKDGbp1OiyHpTJMl77xS+GCQxuqCQLJMHXuZeNYeMru/Dy2coxEWR3
QGj6UYX90xNKZRQxQg5LV5iz7injKN1HuchvfdEZXz9/H+cfNLJ85pCU6ehjUYmcvo8C9VCZWnNG
IzHMV10ql8R22NmxUiGHdFGyZQx+6XrLxoyaFJXu2fViMhbKJUfExfhVPwzkkiIvMuqdbGfWQzQj
pNs4fM63WB2uFe01pyINyZp937diMEVDa5iiJGAWo/gvsWJVd2YtzEPSJMAbXdC+TFg3gV/lONj/
5wcMJWlRmoOvC1hfpw+49MkNo8TM3CzCX08d4sDLlaq+DlQZTEulbvr8eucfGPpMLoWeb0lcNFYr
H8guk+ue+L+xeRsLwBh7q9Y4X50LERDbhMXQR0btcvqLmJLUqF4xNteYCTqj31tHW4nKfd3O1sbW
dP5juBQJPSq/hn54ier5dziCh6tKB0+i+VQpwVvDAcHOb/9XhjY7Ej5iGDEiX1rMJldXUaoMwJSo
JDaLKH2tglx/nrQYcDEJt/ihF2pGlAu4eywudhqsyuUX//Npz8YwapNeRfgNG931CHXFrXuQhQo+
SAoKJAff00wavBgK+z7OlbDzcBE1NtwnL71Cm6aRphmTYqyxVndRSnyhvEhm36LdgfwNRy3Ov+LL
Im+cY5feIHMZgdwTGQMb2umV0LnEhRHRgsRSNBBqFM5IsWZ1Y9FfqPuW7F8VcTqSRSi+q8vAurGU
fjFLTySEG27TK8XTEBG5BmzIBNBRRyXbKd1Ufy3aJBAMVTL5PSpl6yXLyvAlDDTlFvxlZqqjmw3c
oXShiujgXC1ptIO9D4qqbTfu+sJbYPRJQYyeGtXa+tk0MXAWzKDYLVNd38XmIDt22E5H4kW6jV1w
2WVOywnE+zwi0MxlKLN+4Z1sN2IC6wE977Nb38jNp1DtiYMQRvylxjNOhYEwNhvL7MLLFwaGJ2xH
/8stPn35YtbsGA5a7Baw9I92ZZYI78qtrIdL35QCWR2OPDsFe99qNUcC+hrgYuLGuRYrLnh3PLoB
GYgc0ZnR2FSnZajsfDUgLlkUM3RWK057XJAnudl40BfeKTY3qNZI1sVfTFttjlKUNOKDNkvtFHuW
wuwH+uh0sJQ69P7rTs/MmKgYJAEGC99YrflqVCI7i8LU1fWx2cFZxJJzQJD8+VU+WqbV0sHyEdI8
oUT8rvV4KbD7DJoqPLVsydFrJCP5MdGfEx8IWeoIwBDt2jktd9hijm5eRbXXI/yAYV8WLsCneUPe
yXjXEhPilpDDIkc0gXyLrhrOZ22XXpvVLY6+ovQqqai8rAcA+vwnXHgntFccIcwwOBfXmjUVpiz5
lQT2Ko1p7vMaxiTMrhuwymnjYV1aitjJAcMQZIRObk3/R4jZ68yW2N7VmSJ37iGWIUQtHyR6pae4
1wJSAML6Kaln44ivJSiplNsbvvMfdu+rV8Z02jSWCAtK+rXvYWmMMIYsZl1jmxiNgxf1fKdjZ8W0
nnhNT7LCv/UYqvDqEvkgKUP0xEak/R6tMVlYM4SzoN72miJD4EmA2bGeUfgJqDPVwe9VDn04LWOP
NgRgPE7TaNfLCz8xq+Kv4yS2jOYv7F0fxHQElMgqcHk43UXaHCqYOk6EetVq9AWUxnqJEthJGf0R
kGwivepgyhtl24U1g8qRjD5qN2qCdQ56WrTwpgfOaUwcoJ10Ir5tugoiIE5yG5f6n3Xs6n0tWQiA
Px+z8vUgCeA8CbMwRmlfwQ9ydNFLA7Z/zM76OIUuJ/cFfIAGkRmy9yxJXqNkxk4wUKunPGxs6A2q
N9mddFt3ecSHGmWy7+Vijl9nA2UBUF0KK7Uri6TbVfGQNgfEnUJzZb9Q9esAe5EfSlKIH6Uxqz8L
BjnZTmon5b6Hpi8xndQNBKU+eClqnibDGEJg9Yk33BD8qCLSRdECWwQYmqoiPbahGGJXdHZ6j2rR
+CYluXlTYDMP/duXx/ukmpmY9VYl7uG4B62n9YoUumZblX86oysKZ8yUApb4ZDY19GSS3Jyyi43X
rtXFWx+M5TcVzKla1I/l9CyZVu7vFfb9zjOzSrpuhxJAlZ0svsaodlpCWPXsOZUDQ3PQZas+DKSh
7h3mBpL+UCS4UOwCrcXXtdeJAywB5K7BFkGQq2Cq7kJ6scqDR1T63jRZDV+TNQw28m6Zu14aFguE
S5XMfeZncBPtDOaXi1ob6iHxwQy9dCUgHViGuk6sHeTRByvQcaRvpkbKHLsZpvvOmAjdaUUkvzMp
H4hBTYP4a+1nweSBqNc/jALzKafmiIt3ZiqFkWOkGHg6No5dikeVV9/C97IkbLlrssszP29Lt5Na
JdpLqcYQlcVVQt7Wyn50rbGdScyrA3iREPRx6xYgWtc0ff7klaXVf8G/A66YxMCg8ghnK48pvs8Z
kWs9bkcZoLaTMJD4zTh6xu0Pi8zUS1ojvOu7yCh2KBK6u5RAY+XQwCyDwTfKcLph1Fp/Qob6vFp+
2q1Zykq509IOv/p8TBod3mXfw/kcK6LSx0Eq4GFo5UhGsZxYv5mSjMl1rUy14uqIojwCXSfJgwo/
6jtLGub3cgy60W3lnnjxiLkazIecIpv8lYhJgzJCN4UhYTH8G3Q7eJDbSYUtqvlEC7EgJphCCiDN
rpCN9BeWHDSmVZHkkjMPy6MuDNG3BykK2mwnEmUs9zNytmrXlU1VXfmohohDY4Aau0Dk1bzPjIHM
2I7wItzdwVpBBhpczVj4JLSDu6rErExhQZZvL2mtV8nJ9L2uhd9f60rZdq6UGCkBWWFJoiE03pS0
Q1WMqSNVuQaeUacMTqowSObD1I84yPfwTcp7IlSgfILsG8md0kzmF7jVpoJ+LDLz41z2kJMDPt5p
F9fW8BLgPqddcUZppkPc6nBboAh46zmufoRSUtS7hCMSElmG7NeDzlqKnRQYnfpgdwmuTISoB+g/
ouB31BIPOBQJfYvZCL241ZqBbbKWO9ZKbAAo7Kxe66Cg177/U5um9mtjJooF3WYw/1SUZ0DYJOQM
uxxm7e0gokJ+7y1G146QGY2ih/Dtd2iYPmykPn7UIQd9kajpn8NsSPeZPCRkqgdtnruSlc6QRLAc
vI67rFZ3iWwEvycE01/gdGy5CF4ocBH0goWBitHkrMF7XWtDPZtphdEYWG5KlXmfSXLy+7/WL0DA
mEKCO9Gpogc6PQCxq4SBN3IVyWwdpboNcOqp4v3nFzn/KQivNVrhxdQM8efqlBWt2jLz4/QowW13
ZtWzwlV7CxA9P1ZN6C/IpHhoNv3v8vf/tL9xA+ksNAhSSchlP+qtLu+NeMweG8zdvc9/0PngZzHH
YnIKPIxxubkavARY1woavtQthhJBe1CD6ZW9Ufwc/Nm4nicpzBxoHcYrSfbBcIWZTrP7/A7OHAuY
cPLWEO5C9pOxVlo1A7D2NL1rhtTt+zqWnwGfs9JtOiEK2Fu6rzl8YOHjALD7LoWqQQ4NuuaDrQUV
8dlwtdEWzNFGcbhy41xGowRuInPEuA7kgfni6SsoQqurR+yyYCc12pcJ1AjSkk4QrVHkFedSpmm/
hi4tVfhVWHWBoQt2HyUaoEV1spr90EN5+qYZEb7e0xTmPz5/aBcgZnPpa0ha1mUg1jW/AhrMZIoe
krpI9Di/Be9d7OQbgSQrn+Adw0eNdNjQlm/WTjU17W999K10Z7QU2k43FlrmIIerH/u+mRcytTLl
1DBtiThVzPMhVRI1czGLQgpmVpVUHSQ7TI6G5VuVE5ZkUnlVV5XNxnI88wziuYMhWHAUGMzxDlZT
pnyeg05uRmgKSQIJgtRb9S73m/53PdXDI3Ve6bt9ptgdDeNU/iKEvIywTSu1FykcjRbClDru1MG2
pKMuku45NJgokmeB2ZlLNJGpba3e5Ys/rUpx6WLIB9wLnkgo3ulCYfpVdaPNqDZdgDCltecXS806
l9yk5KXpuwmGqix+zckcfQ9pcvdT0ivZxrZ0oaMCJcDAl7aKc4ge4PQuuhLXjwDXCpr7wZZu0NlU
FWiu6v9KVaoBN7HT6fvYFgkBCMSZDbusKKsfzZwnPz9fmBdmTNTnmFRotAVArWvLtz7FoSyB7eDq
NQn0aNYKR8H88SZQtPE6Vksyu61K3mHuOj1iojp+YUEgdRGJ9GDmvu8NKJt3zOGnK0r7ZG8L3ziA
Tmh3LZDLxmo7H7OTI0yqLgU6Oy0TsdOnJiToKAPuR26fqNois2+PsMzQME5z+qop6VaLvayF1VoB
vmS6LjgMATNX1+s79IOZP5J5x0ziHv5reVW103i18QouLEm6MevDtRdDnXWjNFdBZsdBlLpRlDJt
8McGCpwIdAka6CjNAcTBxsgd0yBuhUSBPp8cHSzlPZhlY2MfPX/C1sLaY9wkgOjEmgkzm+k4gW/E
AMh29y0ShbVr0nb6qs+6eg3nMfqy8duXR3j6iGnJAB8/cGIQ7tV5hkShUOt8yYPsbelP2iAd54wV
T1VMs1eFqXZH7mwF2V7rvTbW46NvEdKppggtHWmSssdZEHiDswo9/uybG6O+C3w1bFvoQJexNlDL
GkUkXw6ah8qYKK+thqQSRVrUGYkk/42tYQ53WW0bvwwVn2UarbZ+1BEo/DWSrE48nPEs3Rss6JbY
zCRoJrHpbtA3yD47f7GIrRjeVz+CtA6etHkyf9aDIY+7Dmnv/2NAD6uZfYvXygCAffr0y5ni2lZw
r0/dJilge6p+KPV3UxGMLUeOqf6NJql5broh+FozSIRPXkvKnT3VxbgxS7rwvrGMQZFK4QBSup67
NYrcYMKjMJEGJL1qkS+hamq1G6bnWwSNC2fTEqHA/AEYeDlzldMfragkWora50fPsbGXR6u9zmcj
fdHNJHoROFp0DiVWcOA06JzEwpI7VfXgphFGeWXmdX8E783vE7u1nSSqiqNEpPiVoBVINkZ5S8W0
+ggWMt2Skg1ngun56Y22IdQsks9Sd1IH+V0dmxZhntzeYEvd3pqNFKJS7cujjY3FlgXqhQ+eQpJB
qKVCNKR6Pb10J/tqPatFhqKk7ic28jBq9wkUjgDSbmE+hFD94VbHcwvvyKzsn33cD19suW/kXQ+1
0EIZlje3UmN1oQcii+lj2k+QzoygFurG/n++H+NBR52nguNQzq/3Y7Pp5zlkk3TVxEpvaakDzxBE
4H2+J116G4zk2P50XSyMkNNHYlc0jF2PwscKiv4lyUx0rABBv0cKlse2qUZaM79pnTzX7Q1DkAus
T041QDsQziVneh02Y0AdTyX2DNe3sYnSMR65aYy4d4nTKf5CD8Fo1S78cY+0d3pIbQgNTuyr1RfE
AMaB5A7/qUrmemtWeem2iLhleUERYdy8JiAFil0DrhWpS+Mea16GkOYFc3HEVYmtQsRS4p9aTSqE
kinsw3UuXruEbKGdnlnm0a+yEmFb0GyxzC/sJZjPY5wGBAcdYp0SJo3wY5JwCZKPu/klYxqwY2al
HxOLYvnzNXHhUjSQSxoZFAbiJFZrwpiECgvXb8B8cHWo8UDwlChK7orB2Co6PrwNT3cD2LUk/LBT
f4DRq20r9LvGJ7y2dccy1cg15+vc2SCB8TEUQXmPsrrDdS8skUBJRQvWUBs+YszGVt+SuGZaQLBJ
+FpBAhFOJHfho2qR9IkEjb/0NFPq0dHFc3VtmvH0NhcBThNJlUo7085k897qW9XYtyAi36EkiTcc
S5q3FKXjVyGJX4pdyl/Rrsnfa6O5BpVL93NfJf0OM9UIM5B8lt25rTSOlTatgkNBEKq896lsnxq7
kXVYrDIUyrZi+TPRi+3Zi0WGXYGUSjYGmmUPmtZLWdg7Y2n7f8SA0vBAxNEo9iHQUOcsMKDqFHlG
AntB+u/IYDknaalPlZbJIxSmr5FfKxUKoWD86fuQXByqxmmE99PPb/o04iggyM7L+c8jiaO4NQAm
0fGNf1OF7eSgwWaY0Gga6asaGMZWB78sldXrhXGn4PMOfrjQ4U+3F5TjCJ00JnM8T/9I36x5Wm0P
+zLRlSuMQALEgWOzsad9nKvrq0K7gjmEoofEqhWBIhnGbm5qKil7QpcGdby/1VGcP86xbDAkHE3D
a5BEQj6WehKuAssDgOwOqZopT7Vsz3vIstqRMB8UqZpc2bc5E4KN4vPCZOGD1WRizLsEhazt8lTd
z6SOma5rImvfka6QeAzG4l2OLen3KDD7e9hMFjRrBuAqFelDQQl4m/bGeBChj5Du849ePT8csdbX
cMPHowmwf/2qknKQlShcOM96XAiPSVifexaf3p9uKNEDVZWmt7twlNXnCRr862QVkbKzRC7ApOAD
/0gqUiscNO+RAX88wnvELov4lbSwiYg5vOCpbHvR3Kmix6nEL2tJ8oSOSQUqYvpO8DZ10D2t6iL7
CsW7abjoOqfItSJb/R3NAzrJOUnih3oy/F9Nm3fdPrCN6UHTlOqaPKBQo5lTpT9tC092q3RQ1wtZ
XZwGceQD0YNft052D5mgIgLVR6YOz2ix3XZ2+sDFq3MTf1x2vNPFC/tnOfhp2uE7rYdeQ1AQh6tB
yBSe9ExW4Demowf/av6bXhN+NG1t9hd4didso7X9XRETXKZ0sI2878fnP8/H48HZuVeD4z0NzgYX
6MKHeXKt9Yk/BbD75eVaN/vXPRc6HA5/X26eNi5zAe9eLqNRYGI3Bl9rNbQrBjloYKWXbrVrvoy3
lTs99lf6TbofXaxz3MYbDzjrHDE1Cbz5Udrb759/S+f2YGCB/457lxP2nxlpARNxiATj3sz5+ewc
393d09PGJc4P6dNLLJ/zP5eoS7Org+USgHZO6v1BRLz70zu585LsIw8rqY2i4OP7P12XpxdcVwVW
gPslAy0Xv/Pd7LVe6aZ36hHDYk/18n11Z9+Lg/ScXI1X4R5n9L19KPbpTuyKvb7D5cnJ76Yra1d7
8sZOeuGM4XFDsWSYgJZrDdijrAgwM6oaV5uljuhGtf3NTFZ4dRYQwQsSC+QZxhvV+dnjN5kJw1Li
U2W3ZLZ1+vj9JoLqjcmOW6dSdvTNuLlGgkpnUZpbXeR5a8cFgJUXLJvpDBXZ6lpqBejGwe9aOS5p
O3+Uqt/AWuI1IsX0u6R19HZ6gO087nDDC/IdAi1AM/S7UJnF71oRf426k51sUudXvTKnP6HRtE/g
R/PbxqI861kAUNi5GDgujfdZyiYNeWs2ZUVutgSB7jAHbTUQn0Gox14T1RTdiRhJnEdWcY5dRz37
A24e4wAGTkcFboGnI6FdAECT08VRVzxkfalujTnO1ovJ5IXRkywWWiIl7unjzDkfeHsqev5JS36M
jI7/TnqGUMjOFP+NSCl8ec3RmH4FZRx/7WcZNy9cCug+sNiyCBQTKFLd1EwrtDliyIKj3JfQyocO
58QjhpR01fYyL9Hstn+A/Y8XF92TifJSK9Ew4aGU9B5OX8RHKFoKxmhJ0EkPpPrO2sYyPd+JAGtQ
tmC7sISeQq06/bGa2ebmkIz4T/SZduxjATanVtreCs2eAWhqeShB+10n8LULO9AEG5n4ribe4f91
JxAI+UCXjWR9zrTUtmqaUwqGXfZuAZc7it4cQkW6DqJAHJR+3EP7OppTPnjVnIG8plun+EdNdbKH
LU+DhpPsHxjM0DVOn4ZPKVE05nIPSjPcD/DYgdRJj3o3As3ynSbIhAvBiNrelDl2A0yQBlmQxwIv
5nEhIHlNmM/HIffNqyYI5TtbA6r2Ozm8rQe920e5X2EbNY6HtGJoO/nM2gFdZWwqEuCNQqvJl8Ut
IKtqTCOattpbOX4fhdxiW15Yyo1V1+3Xzz/K852KHwoMgwhjYSp+1KH/HBRxjDK5sXX6jcb2X3F9
JdS36Mx9OsnV83+/FJMnFppCaBm1y+njxaspqdsIxUqnDXASUmPcE1kaOgjqiqvPL6Uum97pq2Qs
wjh0ARX4ZR/l7D8/qzWlKaigWRLVMGNdWw2TF4R+fgiCevIErrZeUdg5CBiGYk7PlNXDoGAkCogP
cxCLJZ40Tg4SBhnVpWx8l8u0O85FikXCUFRviorykNSFyrMCoT1mYSY9gEaJx4BW1k3jqLzSqj7Y
j0nWAel3uXxUjak65gSW3FZTUW4xjM7m5kChy/G29DSw0NdjMzFh88nwPnMTczL+yGGe5h7+YtJj
4sM42kPd7aVDOjYdinqm2tEVUBqTvsaM9PhAo48EHvvLSnOZyIirse2C0BG5rpfeOGjyVSksRI/V
YAKpFpBZvyptqf76/J2db7wcYkKALSzfHyO40+Wh2uz44ZzgXRX30b3o/PGh7MzhaM9KAoPZZmw5
R1v7zvJJr9YJF8W+A8krjLp1dTBIPoaN5DjB1h7aR6YrjAWgJC28meZxrDGtmJNxftVaq9woQ887
PF6ZqS3oMZ0o2t7VbCMqMPlkvp1DnEmKK8IQxFVZ028jE6VB8ROt4NroLp1RwnRzUvBtGuQQG5dO
1AgqY2kLiTs/nhc4neOZlcR0fD1DUjWcVocUmbUeca0KUsgBnom88Wle+t3sAUR7Y8+OonsttCLl
IkkyMgGJ36ytW1zrgy+TUqUuurPwiIuE7vlJpt0XePE9ThqEXoyHxluj7ps97mTTRjF+Yf/jPmAq
YCwAbWFtvt/NBAXj/Ze5IuridyPOMMMODP+7HNgUKp+v8HOoc+Ew/3OxVak24T3BWuMrDWx/3IWR
cY0MaA/gMeDr0+SgONE7bxg3MAvLkSw9bFz/rHlcrk9Zg301hu2Ep6w+sTSBukyj6lZTnL3EekUV
gm0RAgWOGRIah7cJ/sYD0S7dTjSldpijvMZXLVNem0GfNkqtC+uNLQuFBEOFZcWtRv1S3VciJxLS
TQRMqMCQ9Csdr/qt9XbpMjhG2FSeDH3QtZ/+aFObQyXsbegQTHZIMbKaZ2VS6m/hAIGWj8kqumOR
ZflBw3KejF6LOxoHuQmdRk1S/q3GEZHkchCDm2Rptfv8pVy4vY/TEL3IgnuuuT9hx8aUm7yTQGeQ
3uLce2MklX78/CoXljkoExbQGI0r/GG1uSJDmkwtIqJnsvALm/uIOLs0Ri1gcPR9fqlLP4h6ksZH
W7z515Miq7AhQthsI2QR2DcaXosBpkj5/PL5Zc7Renq6D+aPhhcqR9RyH/8c8XoQlbmt4Vk1Ehfy
gkNEFuP7FlsGY1Rqwykc9PgqG5up34cFccVu1IeD6RBMaJLDFfYvqj1G+QGLuC7cSV1ZRc4cWBNO
ekXeY8fczpkJR7cEWfn8zi89IPihEICgrDM4Wt7VPzdOOgU+hfzf3WKGWW01mk3ut7WV7nXhjQNR
gNugPUGdttYpFGGhWG0EEBGLIMfzUG52qqRlFaTuWWx8yefi9EVoBO0Z5SxaQ2ONDdc6BlchBBcY
cgPtwtLTZLXIH/IM4960EHhhzursWXlh3ikqSY5JkUuuH2j2A5C/5HVyT3lc2+3TCFlwazp34VEg
f2R7x4ZnCcBenbSihFXELC3H/bb2OwdwXP6jzIHxk1peWHeTL5skxCISvS9jVSt2bUpEsqFaEBBM
PhUfwzI5I9raHCmTVIU159SVLCTnP68LTF7gwIP943azbj+KIGK0D6/JZZBRHzsF1fOsbh3y5/gV
CDC5Phb7IZYqRFidrj6tQPKbj13t5nKN4X8/YgVdzp2nEEoIDzuKPBPruvu4aML7AndofNXtOXzH
HPptFpLqMdgqt7boC9U60ZaKQC3M2qH7Pr0njIFrCNAaPmGFOTyVWotDgVwlf7Eun/faMHVXhEXt
pDj709Jv77TRLg+DAAv6/AV8CA1Oq0GGghqVCdwa+uL1UYEVbl7h2Fy5hlVqDtR4/aBGMDCw3cp3
RiWS25Yx8E+tTGWnt+Lwa9xPEzKK4XdiKU/KgCkVIvclEJMswqI1lKuw7XsPP4t212qjQuRpsrWb
nJfNEEbwcUFFDBdR01eLG4tnWy9zXqUkwZ9um8K6w0fYvknVkZQkZJwHKR2sDXD2fAuDqsXX8fGg
mDmtColhCBbj765iSCK3kCd07R6OpbbxQZwPhEkCRrbMSYLERaFEP10XbRD1VtI3MH18O/1ZtkzX
C9ir36xy0O6xNcVmCqND+4dhhDgpM3lRhEswIACXgo/JVyNsw58NZgr3Fe5pULybEYdQwpLMt88X
zrI+V+uGjoXWCzIoUPz6HZjFVJVDXkJbS9Xai2VsT1Jkh3sYqOqXIW/U72Yb4UMewrn8/Mrn83no
hqhM8WCyCVeCu3D6iCqYUVWsc2mth6DP0VLFXiq0+Rt6tCDjfFeyn6UWT49CCsa3CatH6OadIdId
TqfqDpRJ1a9GvVSelVROHi0cbBCNcuxd136c/EkTn1MQuR245Od3fr4pL0cfLFD6VZlKYcWWTBFp
QjcDcBOSPFADB+F90DL36Cxshv77pUiyY/iLio5mb/WMep3SHjIr2ws2PDusQ22ntOLemfB03vhV
y12vVgK7KiI0WAu8D2P5cP4525XGmEatAFtsOy2Fzj0rzymf5M9ZVYLrJRoeB2wc4Cm84lT6VvJG
N/awC4+VFUGNtxRfBjdxegOY2aVYfcqYZYi62gVNb3u5lieOrfXBRk15TuQ1cS/mQkthjK3E2gPM
ymPIeBjXu6Sw5pZbwuf/k9foVJfA1bZ1klGls8bxfbb3o+nrw85kf5qvytQgUkKSsIB1qErJvDUq
W8LbGfTbNTIrDFz8IGvlGBB+iNV80FU7O1Aq35Pswf9eGtjHOz26DJuIENqIjTbtwo4KtQO+C8x/
FOlrOVpZ2RCeMr90k1EPvxJE2d2onBq3OnGFzxDBZC+b4/jp8zV6YUclSwhWPjUtWPjaSMwKmPlh
4VfiPVv4u5I5paPGg/zfC7UPL4iF5YqAEfO50+Uxim5IGmFjHhBNCvqXyXgyxhksEaHT7ESQKo7Y
yupHWyur61LWKxZtHO2IQtCgG2LTUlJkOVPU+AcxKAynP38KFwpJQgxhsQiWFvOY9fcjkQYzkbpR
u0poyT0m5YbtkTGi27iWiNl243BALRISRSsT8qKa+0501YypY5WmWN36ZuDkTWp+D+UseYj8psM5
tUs3ZqbL6Xb6kWvEDQMxg2OooOyrjtJKNfDnUka8RgzJdyMNEd0UmuZNBr7LTpsa4WHjsajnV6RV
VjCoYR8DRFmdt2zCRBdJhJ5mRaXu8Hgy8OWHC9VMavKOppDk0dKvrZ2ItepaT8dhXzeENPajGjzD
STdu4JJs8lXP9zqEgnwozHAMoK71559JucB5W8EsBb/HEu2tZf5KyjB+9/ng/9hDNqV7yVxSE4YK
11e8mkgooMTruhdGWlmx932LDJEUvAWtMb6tb1Ldqr8RqTSaZzWzkN1xhv0vACh+bTzQ84oTUI4N
knqbiQyv8/Q7GCrYtXItS9i79YTu9E0KEjXp41GBbLDT1ElDGBti+VUbw31lm63u9XKp/sYS3Nh/
fi/nO7auGpC3GFVDqmX4eXorJZbU1OSYsTZB+cOUbHFjd+ovpGftxsTxfIvhQpDFOWthgMJFP72Q
FJpRxiLjQvXgu0IkMQwJcI3Pf86lqyw9jAaFEsx17Xkg0qSdkoirxKPBZlJgfR7gUruxR58/NLZK
Vh7K1WWHXqt3lb74P+rOa0luc8vSr6I491AnPDDRpy/gkaZ8kZJuECUaeO/x9POBVPdhJXlYo4uJ
mFGJEWUyE8Bv9r/N2muBFNDE3E6TurN3CLEHE2x87CX14999HpIMGgUuhmavXFyNWkscvYsvICGb
V9WJRCI5f3oU3J9f5QeGj2ojbu7uOODNG/uwfuM4DEh/yWIb0dE95+YlbZb5U0y62ul6CHNmlub7
uBgyi65uVI3HbbILcZwc2IfxwauOsihcgKciTlFGyEf9jZP++9EmsBBpjCDQIHK8hrdgrMUoKgra
l5X2Y5QXEiR0vfyQGfnwxxvj8P3G3FMjHLwUAlV26NXGlOEqxJDkLJ8U6K/YbWJuZaLUH0FrZ+6c
LaZ1wGXVbPDhkhNpSf809l38DsdW+tvUJvB2EBCSy+LZ8Qeu5iSrSCfMFJI49AAtKYdtCTUpzoM3
Hvn72o0JbxAIxz0zDCjl6pFjYVyjvIVvtpK6/NnEFbBSg/oN1ONAz5RDRsYC0Yh8mMaPMsGmAzHQ
9OfPb+L7GSbzT5zFf/AaQDL4evnRCE/LLCclDUpa6iUrYSPJjhGVivatUf1BBmInLkLJGE8cHdpr
CBM6f9jccihsI6kRxFLrYk+9pcUgnlAIqiCrTlT1c1FvemqR4FIu64pXYEfIu42W0sOZA1xxolCy
9Uamv2FYfnR3KJri+MFkSBrgmktiK2Zo5uSiBEVpQNo8wYXnS3SPPw1gv57mvuyO2WE6pHYs028I
ki324al/MCqDnq+VsALpog1l0p/Pzz7+r10O0oVsCmlvvgC+dDU/SK8UiTDkpd0vYwEkVSlDDTr6
v3sU7fhhOthITBJSmtfPLi7ZcKiLsbKpWAl/NkVanyi1b8AB1MMbSbnvHohLUTg1DvT/cb3rRQBb
p9JUwANtc0b+kFA09gnn/3YuGiJblV5DznpaNPnh9bKuIgEO6xkxA1qKmgBcItz1naE7P5+c7xwh
UvQkr0hhsYOBhl9t4LTQtwVm3toujGp5bvNUfpZhUH2ny/0hpHFBs2Lt0AUL8gSwC27135810si7
eiZ7+MBNvH7INJrMutKItEC07MlXs/IbY0QiqUbK7OdP+l1oxHwZezfADhXYt/DrS4EPLROhh/JG
kmrAhqVVSSIibccEB10e3iR+/sEioR65QyoxTRrkXa8v10NlZDYT0XIJEwFNX2blaIjXhq02G5RF
N82R8mzy4TaUbdlArEpFSIYKDngJkbKxxeGZutpYTg8/HwZqAlz51X7cGY92ClJQBlSuro8pY+b0
MVrkekghIOgyj3AX24e2O4CdqaTZtNV8QdxlKeX4lhtAZHKlWeSl6EjioecqKx/TeJY6P1Hj+WUb
5PVE7Xv0W4h6JLuEc4kunLLi7IsbdYXXgsL9BsDI3AZOiaKksyAWxwcwG9pwjKIhpv2qPbTlDcp/
xCUkcBHGS8S1e0oiaIhtJZ4VqIyHGcJgvZvX8ognCuy7whLbMA2QszzEAnrSw4yik1sNSp46CWN9
0wsmvdUb4IbTCHsa2hRVYnwqk3UKtGYpBHTIsg2VCnDqMAFMWndDtcvIIIeeoeo2u1FObCAIwkum
p/PJTIDuQvKQyizUOEb5e5x14Y8asun3sR5JaFZ262+j3ssf46wW/mgOqVpBjKAmtTVKuW5yIIzC
DUK/AgLxytxAvIyr1J6nnfHKaaYB0kcqqWnkIAbUZ07WswvC7ZCk/qLAxOWXsZZsVis10AIadQOR
BRqPB0foJfOPEiEQHpC2098atHsV6zAe0JkTVvpBb4dEwVqJ0E0DJSwXFMvGYtU0d1RbZOCKbIPk
FTJTpmkhQ5h5VK2b36eyLiXUCPoNVOmQLU90AkiKoy+H7rmr5rJyRnNASQg0f6dbNa0trUMbILUR
VVxhMetNHd6deW3Gdxvyo0/IFFDIypp2qLyCVRIDY2yW2jXROK2PWwOHGcStVUnhYuSEQzyEfeVM
0PJOFqtMUx147SkAIvCFAN1SNVAUEkxLi6Ptja9Orm/Fx2zrF3Y3KVPJihdD/F0WwcpYsakiAAb2
a3w3muV2gKJ5wt0kO53Tv7DM9UcSo+PyaB7G9l0OJR2IRPBbrBCC0jOVhINoD2JPk0aKJ5UA5ZKn
uwo5Yzo4ygUGDojAYx0cYoLgEjqSEKSwnxIrjmb9GfKarLblxDRumq2bzjKjKdqjToIN4R1lXtyN
bmkkfdttpjOl2NVDWIj6jhTMDXdFNWCxxr7FFv/cFPzIRKnEj7QE0e1LTuC1iQJotFF0V6AePjTG
bV0Vy2PfH8w3rvK9V4K9AbJM+GZo+4F2dcSQaJDKQ5KVtjAXbjZvXqSYSBcfntRY9fRKfQfW55wZ
GxxesOKviJ7CbnO47crpjQzSd44ibGT04tC1SEmRSPLKJItSYwyzRNtfJK/RnyaiJE5Vb/2p1aL1
jZjo+6GF8Y9kkAHYnUPHvMr+z0o7F/h/O7d+o/uNXESfm15/i1z/B1cR99AG35d2asrjrydQMVdV
7xHgQcB1yL1ZiZWnNO3jN2LvHwwbPgiBNxUTUGnXxWpoaBE5aMiSdNGUoxXTbR4CeztHuv5GBPWD
5wFBRZ0TRB80rNdcl51MrV1HPttWDc7HPNVXL2rAzf582X+P4mFGqKgCrNgPaLJSr4dtVPukz1LU
1qFH71Drqsib2Nsh3wx3jKqosep2GVu4deDmtoRsnd+3sjbX9qLO2a5n0Y7hKI/F9MZG+cHT4yBT
SsRbIKdyTQvcJ22hdNMMTUxXaS5dvIabi3A3/fzpf3AVmB4AbwGhoXxx/fDRtmRdllN0MWNUbA6H
AQfTRIPp51f5vvy1N1yDxuLAhN2W7MPrMZYaXU+lepc4m1PIw5ckf4SAaLAhjmg9yrfqDYlB815c
ZFRYKpXOVUkYEljeG/VOF4vsmRlAJZDcvPkkF6ZmkVSf37jJ731fhpqYlfSIqVLykF7fowLeYhsL
shBiS2uxDV4o8divGPw0VSicquvzXDRwkCGEbJUU6MKfD9KPpgK+jb2dAq8UeM/r6+dS2yNPS8JY
L0REFc1xvjkUhfjGcv/B9qU0T1qe9BkB0jU6WR1zbZozsdkFnzoYlkDh0cjUBkWkVG+sre9BYjup
Btle6g87Ku0ayomKcxGhHU80ka19mKCc9C7bzPV5TNUkkBD7uRtHMb+PoziFRl7S3o+9nGVvTOsX
tOVrB5e7kIFCA5gw6U+/mteE0tQhSkHXaDDTpcc12g6/Jfk4/AmiMQXABsFFb83tXBknOOXkd+Lc
Zslx0tK1sEtjUB4jajXPYl4jf1nl9BcUEjirddCXxC2gx/1Aiw5wU4kE76kw16b3tm0+fMyHeZFh
xYlJ5COGUX42ormTnDquE8FKlU17/vny+X5iIeSjJIITDxs3R+vr5TNk2tKIQIdsmo8yhwhDgeEy
k36jGdp441Lfx057glehqknLGSDLq6qBSvqYRj14qldZTqVjd5A2w2qyWrkxZEpnAcmIBtz4rEJ/
8vOH/MGV9ww9TTBkDKkRX11Z69qV5hyEtRZpHt5VGTId6Af1nqy38h9Ski+eErX5u59fdHd8Xi8g
zDBtHswjue3v0H0Id/SsIBiIja0HThrNqvoeQjj10kfphhuTv8Uc8CWz/OqKe7sNNp9ppERiXpd5
c8KKQ6HQapHnYvtYGhsS4SKd2bLXxsYoh2ssxx0ahbLwkEgmpPFG3hSPulmNyPENRXKXzhEBRd0I
kMIVUCc+6UOpOLRdSK29dFA3hxSb2g91X3UPCScbhUA1SX9HrcyEXRfhrrsergJEWCtqV0jBCaMl
j0JWuE1c5/l5iXJNsBBDbelvHBtETlpDKEVHUwDWOEQ6ymdBX/sqyFBDVywMKqTNbQcRZrrl62+d
0OnJjtKMxmCJcVGsCkv1VqPndxsCpni2OyVIkDhEF/vfv8lDdyqSvIh3osu39f2ZPNlIKwPy4Qpd
DM7PV8h+fL2eL1Cou19HWxC777rOGtOLZRzSaSSfrReXXKLdded465DtjYdgR17RXqFLN1Gdwy35
82t/d2yQKtmFStj2ZEv59/oxaQgTAJdscB1RKDmCRWht3iB/PZz+48Pyv+JP9d3Xh+n/6z/5+UON
NlcaJ8PVj/91ST+giVt/Hv5zf9v/vOz1m/7rtvlUPQ7dp0/D5aW5fuWrN/L5f13feRleXv1AXJ4O
6/34qVsfPvVjMXy5CHe6v/L/9I+/fPryKU9r8+mf/0DSoxr2T4sRIvvHX38KP/7zH9J+0P7Ht5//
1x9vXkre9zR2ef/LS/XxF/slZUP8EvYFP/XffcSnl3745z/gkf2VygLZFAqKOz51h7nMn77+SfpV
YTVKB/xnMtQwLvzjl4pAPOEmxF9NUIc4obDa7WcV7+rr8a8/QWlFZQiHHnjo3oH33zf7atr+NY2/
VGN5V6fV0P/zH69XKvgaUHmcxwbYdOwZFdjXq2WltTpKhg0Vljkf3q2lElviDJ+dhlg6TfPpZ9jf
mneEyS/fDNpf9/HtdV9vxr+uS1ngwI6EMO06/wURTjU3Arp+jJzkTL3cPWQ93VrpgcTN39oRX6/F
KYh3Q94Ay33lbDKU4zTtSjOFAdG2Uaax12vS9saeZ0a+2fNfr7IzVsFQsU/oNaKr7xW91EhteJjy
0h36cvZQjMyDPlOr45ws5VkA/iApftfPZfjz0Xx9DH65NmIDdCAB7qNm/YVs4hvTpqJFsdE7SFcO
lSdXT5RzJ2yXGhVST0K02O3QNn3j5P3BBFLQA5lHyEyGWL0KYenih5ISJmxvjmAajqqDzPBmZIFb
NXkDkveDkdWohu7BskQi4po9CipcukfA1LhC36R38JYdHBPm3jCC4uck9Osfan44GdtUBCSA3irH
XnEOfh3bvaGapwQQAxL49Q7RhD7n2qrgNjAZ2xBybP5hbWWrnBIjKKEecmSJWr9RreB8s43uvmGi
v9+YIS/IfyPpyZs4Ad8Ykx8Nv7yXUwH+Anq/Dk42UU36ukZ0VFEK09Na2P9xjxqLSlf7ltv++kT5
MgK7kCNATHw8ApKr/SNCu5wWgJk8BEXrUz1F6p8JrvMf1dSqz+10mNCYm+3mkFXhmJ+FHQohj1Hm
pu3SQhwybPe5iOjzG7v6i7zLvw7ZL7e1px1oEQaKTwb9ynSp5aGJKRdhuhZ5TMmx6eT9DrAzOGlj
QlPZGoXxBIuveCNPmxwjLLgmdgma/sas5fk4S7PwftQW3rWKReL0irZRcAbreJZGyVsrWY8geI+d
vjOUcxoLf5agvuwkSXQQXqhtBJk2q4/RMpjiG4921fi8Pxq5IbAnexoC7pDvQj+9TsC/Mbs7Hb+n
cpqfUOgDqI26Nto2qFEePpOEh26CZr7Fob8JQLe5gu0fyXwi/7wk66VcBJWcKRpA78sS9J7TxpCD
uaK81u7Pzc8XwrjXU8HhtaOuyAGRLLzGdy9tpJLDVdGVqqPaQaQM/Gxdgc1D6qo8ZUktPvRFIkKi
W1bjBRfQuIP0egYFtUYCLHhtBHGaIg8y9y8NdIPl5AIUSABRtpRMAR9VEqaDZSjxY1Nv813aHpJ7
tNKi1BLqRT+lSa7eIchUPKSFasdF5cXpwUDcdBwUv0166UgvgfqQagC9bLGn/7EWkTGet2p7Rqdb
ec5oofowKMPoiSMtaD8fnu/3DylFIB0EYwZVlWuGMnlSoeeW0W+K5HR6Rgn14FdGq75x/vz4KqQL
kHBA6Ov6lGu2JCMwPUTgCXfhZmn9VDea8cajfO8u8Ci4zthC+txYqK+NISIH6daqc+SKM7Searbp
v6HAUVpxXBVOOhHajg0w/xWh9zeOuB9cmWQmzgAgn502aw/Kvjnisn4w11TqTXdS5Syn1TOnwRjp
5bWjuyzWn+e4S94h1vhW1fwL3djrtb3bGJb3Hn3J+nWI2SVaCnBYNl25Psi1JS9G9E6euv5F6rMc
KH2nCk4J1bOXp3OZ24f1sAX1UjawIGUSzOWLoTfnJD+sH2EtOrczgjlShNUgeVV0TxGx1GlKdPlp
E+IGQrWqSh7gnS8/aIWg3MqNSf/1mEf+z5fk90fqV8Opy3sqhMX5ejSXRm7XpjmYbtKYE30IhvnY
qO1Dnw8YeH0ZPShVCd6lxCf591Y4++MhZcPt+Gj0J9Wrucw3RRGUQ2e6cOuP/tAhrRoJtOPREq77
COVNt3BL1FazzuBis5oTlly5txUH+Q6mgtVtK+Ndru9FyCTaHEXaYBU/6FXQ1IrmQku/y5fOktMc
mk+xrNJQX3YvRdpEN4Mkv9Xa8mX+r9YHuwFbDcbJ2Nk4Xg9ljCT8hOK57raxpD9smBOLCkZ6SspB
hLaGHI+9g73CFLpUh/yQGS5lV9+hHBu/+/mk/vBWQG9K9CnRc0cE+/pWlqog/5LX7JEu7ziQx+5l
GmEW1eSxDw1C8Vs9obrVKnFptT1CAvmqn0W5Gx7euBGJC12PCS4wNCEAOsDjXi0vk9ks5j7hRtru
XI1SuG0qKQZZS894aINVAJ23Czk+IySgBHLTmz5FsMJpUkl9w2L9YKVTlMBSka/BX7rONCeyRCMA
jp3b9rX8HCc5guzs1FMvVjAWKLHu67H4YhJ9ngS0Yt8ojvzAKJPiFrGWxHDUQa58lLqNBj1rufpi
RtEl6k3Dk0ul++ov/N8IxqdP3TB2n34hFu9/8cbq48tA/Pv/QVhOnEqwwYr+96H546cqf8nH/47I
/8NJX+p1HF7SX+73B62/DdH/5+O+humkL39VtT1hyl5UKEdy/HyN0nGxfwWjAcXo3lvK5mIt/3eQ
rv66l4l0jkT+sgMp/xWkq7+yp/Hi9kgQPRLQ3n8jSKed49WGEnYDoxicfvv6+ubUU7dZ0VMgRJcs
TE/tsb8RboWAWrBDNs+4SMf9Rwz1jebqjTV5cKoF61F87NCKuo3u05vJi1zoh96vQeTCaOlmt7Of
HgE5Ov0xO+cvRVhxpEGRvlpNqPjjKXNjZ/HILnqRnTuSo7nacQpzdwoUe+T7xZH8xskfoqPktv5y
QtrZboP21LuKLbjTSXaSUAhWe3PEIA26cHVhOfWVY+vnfuasruDVgXZsHuOj7IhOftMjxWCNF9Fp
wsZrPNUrb+KbqbZET3aGQHGEy4wnj8TCOb/oAZqWR/1W89ub9ZI4Wqg427G4ScMpaLwy6P3CU1wh
GI/Gsb6P7oSb4jE/mjf1pQza4xB0LoIQPGdix65wUX0YT0PCNJ3K/CW5LQwyuZaWWflzdAePh7X8
WR6HUHFzN+NjZa+3PoXwOUXeEwRvtuhrTuqizPVZsxlXrwm0L7ehuGLAJzitLztboFh12Hvu4S46
L8fUr/3cFaDhGoLRB57gzV4bbq7sd6fREf0u0H7vTr1TerKtOfIxP+suSQQ/D0V/vquCiXfND+V9
4m2+eU/Ig1H3knuEK+zcL48jnPz+ZKMY6q/OZBOUW9kxOWZHbM5n8Zjf5R+lD+YfQ1BzHzsv1fhk
x/bsoNtrT6567M+zp93WoeJF1uTmfhMcvNJJgvGs30e365kAwjl4B0e2K6t1tNvs4XAuP27vWkCL
kxWTFqbtYrK7m4PTuchF3piXPswfm+fKbcPl88EbbDXUnZIPSe+S0+RLQearYeYOcGXlXnaBBdop
ELsPEQ6kSTF91O/0EK+A0U592cYDyO+qY+qoTuanzuG9EjRH6TS/F8LSWR2JmzXc4UPK96tzCJSH
8iSH9FdmxHe2caM8iHesRD9yU9i5WvbJgd99HE/Fs3iX/sn+4ZXZvR6uPg1t2lHxBS+9zR+zS3aW
jsVZu9Qn4yG76OyA7gxN57E6Kqf+jQMDHPm/2epXh/dcj1Kt1a142WnGpoRdCNOYE9l9MEJ01nAP
nfP58+Cnns6uLMImxPVxD+5qD47wJIey1bvlC5IMNqJLluAM3uxK9gGatHeIynijNdt4Iq4Jl28A
R1jIDvPyQAz0wco+pK7usorsxKHc6cie7uWuwXzLrPLhpMTH0s/tha/BgpfQKf0lqO/VkxgIrubE
fuwjqfKJDuxCP6q93X/a/iyfp2A45X7+DGRqCVJ/vW0Ck9W/KyidHgRbt4V3itPxuyGIfk88LSxO
Sgj6wqmfjd/jixSKN3F6NlhLF+2WBRmiP/a0PagPutt701G/lHoQh9MxPhen7Sbyek+5pau1vjN4
dWTFNgygl8VHXp7lDaeNHXmTjeIRv/88WoX98nthfaiwCjN7AbJ1B0nB4+DI1sfPGe+fHfYkr41s
YEmwHZYOn+T2oXqcz1kw+RBWXoybNhi8xVG9KSwaS3Rmd+TFqVcp1hqYrEfhFL9nxcEZ96JZSM7Z
m61Z+819xIafFZ9JuQin6rx5kzO6s12748m8I5nDT/nN5g2e4RoPiNwUvslykHzJVx3dSZ3cKdzC
hdHEqkLhdj3u1y0u65+A8iB1JiTikigCeYnLFgjboHYVPw4O7uLkFh0tTndDt6QD6T3EdLOt2OIp
d8nbWKkHVMSarc5b/ZGjpndRK4NU7zNkUPbkYPWtxalC1TGhHbLMMONVbXB4aIPM1p/038FtsfzS
3zo+XXXkUOAEEljGCCm6hq070QPwMossmS8EDR+SHJvn2Hmr1gMt0GvX619H5u6bfnNkznqa77CD
w6V1tcvGUQbvoS9Y6BQFdLcLzEnnbF7nGDZPwFCOtn5OmImKs2phKExHcB7JSXijq/Jtymi8Q9fM
W93S+ljZlT1aMA3ZkT8xkgDz/OK4BuNpZBsO3uTtW3bkaovzh+Fr/uRxNFtg/r3Y7TkVe7fzCjhR
WDb7IckfnNjlDjlcJ96NVJ3XhcYxwlB1noEpj9yCLXz4YzwW4f6BfQAwj21d3sAPzXcJRhO2R75G
t1tOhj+6smXsBJD8In/Z13MfqE7Nzwe7C/MHhQ9q3TowWRISl8nC2V542P3DW1cMMxbL4Hx9EPpl
nYnVnbuJYziFs7Eqs5B3XRDFsgFivRt5Oonlo/EwLK0bBo1DXPawXjw5e8OrX7InPp9xBbVqR67m
HvzB2xhP0SndlC/Nxqs48nkMN2tKuCueI9dwW25p/cy02I3DBvyT7rz4MYqt5BlMFmsHDhdHY+QK
R7C1cOe3TC0F27l4FdNpskxNL2HPOtTibcMfmNt1X+gOnObOysZZbdQFuPuvYwZNPJMZezFnR+Hu
B6PKQp4telTYjWy6EDoXb1/KgBJ5n+jUXKTiGQALq2cRLsrIicL9cXZXafDG0xpgCZg9EP4+A8Qr
kORi6dXBPnioWv1mXObjynD03LXB3ONP+JFPviDsj+2+UB3NF273mYYnKaiwAToLOPY6v3A7+7Hk
7gU+frQq+3POTcFhbyVYBTJvX8ZCtTJuumBU9kEmIYZTF7F6JA4O2WskbgcWtmAOpNPga4EWDJzK
ELu5ZiCcsEEn4W4O+mBlHe/XUvDy9j0SO5kL2IHLiBwVMzcKh6HfabYQ0vvA1SRXZ+ftS6I6Y5sC
OkD8COtyYIklGI/I7fyBIcbvsIHp2r27/bb9loS1S54y8TFX1GaxQTpHvc76VvwhtQpWHpqPXvun
Gaph50nsWclP/DmAZuPLSk1vDF86Tp4QdF4Q2aBywz5I/H07DLwEmgxLxgJP7oobkuDqYqJtIYCc
6YOCGTbPu60q/JEhlVjS+6OOVupUjKjMMugcnVWFVKm9uoyoz5a6N57ne+UGm8Zcl454KZ19vKG3
ZtnlAe6vw6dZuTMzIzKHCT6SB/GQVfkQ3FsHO+U1K89fYxEMf2Ze5hso27AlBhu5xF1F99CNsEUy
dzVxULAvcKMPvnFRP2hs38M9Eq0cMaTdnOZF8GvMWs17Rrd+N7MdEQ/mSXoOFxALLOmO8ZZZKbon
MVNFiP9q47YFaNk5jUdW1I65thgaLlRyDs6cXTDIg8fAOocjGVlmFX31L5tbxGLtJ8++W1cyq1+s
TOWzU20Z/7Ph0UurO/cqi0TAamo2repW5IiW5IoemoMzb/ty6nEr0znBt4AVzBKt/CH5WN/sQ03X
JzdaMAxYT/7euCYuueFnTxEudnNb+i2OSgIXa4HTvZ027VLdlvfrJ3AnOApIRLsgpIMuwHKw1enu
5WXmjQk53omoxC3Yx/klPhYVRloM+PFYeeUxP8bH2i/WM/osye1yai/9pf+U4C3vBK+alds4QXCL
PhceIVXAvXiCVdsgqz0WmJU4s0/a2kovREVWYY14SbXfeGlALzKvwhtxMkKK1CrtDq9od7sE4hMY
Gvcvb7AOHwU7JmYw7cbd/ZbGZYK89TLeQBlmZ57hDO7mmv6Ao7YEjWH1fLzkykQlUYhUpHnTBLK/
uS0uO2nJsDmpNxGgWmvgm8Oj/txqKGi52hlHzE28crFK3yCUUH1NtokCrJRhMRzT1Z4mjEk4nKKw
fmZ8WSiKI92ORCHVSbqbBctorPRZCSU8OPkP5aPxpNylPsPDa7PHmNvRfk8/mTfdSbsr/diFYDK3
wNvHiLja8T11PbcLSp8jEjdz90OpFalu7Atuy3OWeIoxv46Il9BzsiZ7dCLrwxDkeFKqzy8sSD6t
O3zTl+qlr61hdfNzeo5r4prRk31I113cvIA6Ptq+9NenofkHrKcJb/tNeowODjS9Ht/UT7wYn2+f
XmEP+nDDOvxF2TYYwzrc4zDzy7yZfGDvZS/KchL+wD1lAQr9OQp6BwbNJ2pNUph24eYnHjrCTva7
yHr4gHylFX2Yndlb3Bd0ATEKnYWOIDuRe4R61VUszdJYXb2DNIk78NPq7G4oyhAWzANsKmi3uUQC
GNrILWIuwkuKob7kiaLPb1cBnq3PPWZ1gPu5tuaU25E+lGEadm5ys6ne8nn1Ojficrt3S/1kIfxq
uQIC7hageO7xy11Yph8bgXAveZrXevttDPjJGR2vH4uH4maNfcWrOdx2tw4nCLMWsaabgED0gvaj
Q2chZiRzS0djP4Ak9UReA5+Cz5nDxLF27ZfBRr/U5ubtfdNQvOTfPgEZXujubO+Leztu9vPnzN/9
2X249hBksAihucjKEd3Yh/cCNgoI6JE+eavjyN5vis4VK8MASQx0hkHCOycQkPidyLnDJ3Mu6th/
SkF40rtXJ5zgrsCnFsGbeJKTcabmeFI8B4NOGOpX7sDNjs7GjTR2hJHf3UETJzrlPDS89qnG+Jth
4S9+x+1vruDvr+T4tZdblQdQAvPIOnpqQ8aLQ2l2+3ebl+Neo7vK2Zu5k28EDdEGB6m/518GP9nN
sLuPMiEARhm34DylVv25x2MUPOjSXbpHOVtwXCzewA3jSHlJeDimN1m4+9gGGpmeZBGBKM7Cw0j4
CM0nQm1OmD1cFPAqvkm8/QDegVrLvwljrzKeBpXREhZQ8YKTiqdJX1hFYolz3f2In+JqJIw4QyrZ
JgBgAnQ8q5m4gqCT/W1gqeB7scH545/tbu7mxEFxt/tbSyju54KPTA6ngkguCc/U2m6jZxKrl+5s
3nah5E7h7ItkOKhscFqQY8Kpno8qOaP+XfG0unEwhBE+8mxrWOwD1p9ETVAe+0vhTacuqPinORgh
N70MJy3cLSLVkMdpD9u4w+n98n6x7nQOodLvn+lcuu0v2WP/aT8GxKf9fCtJ3uSuGohWzRHQ3+un
xfoAtROWfvliqkxL5euw23lOO4XlnDhqsCUW3TscHSkmuODFmZPYwx5U7ueK4XQnAWsoOsZR+wyy
DrsCZG7AaGfeTkROYokk3X6kbASWMy4q17fJnEBIXnCJzEF+A3dtP5QW9tvsYCZ4ze6jRfeLt3s3
KokGvGZLerc5u2+wp+8kt/FgK2ZqdJuz1Bd8zaud7cvjJDifkt1ippiRnmMEagG3DrdjJd+DsGHP
1aSyJiz6YM140ljyBS08fyRB1HvaI4+OGYiszZ3eCfdU37EH6AQeU0J9lVN7CjiY/RV7KbtsDuKs
1MvwlQx/wf/pvN2PhAQGD3H3sYkWeAZINW11uDXvmsvhfXZfNkF6wNXLLjPbezcikiXEtl3ihMFI
UuHd6U7n7Gty5vuOUOu0nmLvmSYbeww7C8FgbERxv2h2coS8w8qCPbQluGbPzswjjrnFBrzdXcQR
/2d38WS3PXiweTTHwgUfbO+O4cLAjSFHK7aE3gJuHYuAW0YmB6eukc97UKKzHyGVwEphx87oBN7E
d7OzYJP2lEOJmanwxt6q6gId+De79QrFU+ZoWxeJoV8QYblVjmZtkYbY/b3nw8P2iC62dJm8zdkd
WQPTuLuWolfdwWhDlnn4XQ3TR/WuPpFVu98+FGd+/zm/0T054Ix3jaOBS5LcRuSPd+8huouP1eN0
ak6iLx+3zzX5zRifZ3Mlspyrl4YajuFwJoDGjSE0DidcYoI4D+DkbYGvod11J/15O5Lfc/qQQ9PN
jzVLJD2XSJzb5uV3DkdMP1T7OQZvc92KpIt0J/0+HMszpxAOrcRZFnkjSc6W1IQW9KF5b8TO/GFa
rTZsPeXUnszbIsS+Y8VJn5N5k29pFzzpIaG3uwf4mW8GXwzm3yrhPNUl/1/XYl5BK/8t5PL/RSDl
XkT599WaHUhZfqrgOnh5jb/c3/a1KqNpv4JJ3KnHKL5DUvEv7KQKdJLWahoJ6FyA/HMH//xVlVGk
XyGghLMFrqi9Brl/3F/QSVkFi7lLO8F5ALWmrv6dosxepP5XjZNPp3INlQPtcRCBmrDmvM4zTVEs
V4Wam67UdD3dVQq5GNi27XWeVX9uk7fkh1/ns75eD5gdTwbN1E5z+Pp6ktablVmqCOPkrZJZwkDp
2xDiSPpaTHwF7P0WmXndpfHlwUC2GzBU0Fn+HU5ayloDJQIUeIrDspaoZI994bdKqt/AWqeLF7pX
TVSjdcBglphrkXgs0Adr7C2NlPqNm9kLxa8Gmd5DFCAYXgDfDPVeF/smmacoKZhaVYvc5LDlgdGK
8RMMwtWpXDdiiG+W3w98ln0Ar65lMJEUz0G7UQe8GuCl08d2XA3THZdFoKGoPdwNajqEA9Lj78Wh
S05VsqV3gjT1H35+5eseSIB18KqBm+IJv1AgXNXLswP4JVGbTLfRxflc6EpyP4had6GtzAQuPx2q
xaLIuBynaOpvE8bZL4woe+oXNaOe0mjRKWvq8vmN29pTpdcjAo+BrqsybQ4UIV+PPmIVGQrvELmp
ddt4SCLpQUX7v22sUmnD8wyLkbyYntzF/5u9M+utG0my8C9igVsyyVfeVZslW7Il+4XwJu57kkny
189Hd8/Autb4Qv02wKAbhUZ1lfOSzIyMOHHinHRrNMN0UItRXTlN621nN0LM4u+/548Tx1uC6+fy
nvAC+WNStCqZKBeKD1Qv2LCHEEU8jZx5h3iWLrW+qOMY//S/r/nHqVvX5EggCsCBp4n/8hWospyh
ChusiWrRdVHEyIRWaOX/fZU/th4sCRPSFvRkmtzswZerlJgzoNg8Cai7Tee8G6xRJe8bMx+QY0Wj
+vvE0DBDsXYlm2ONiNg5moL8pUj9+6cmqECmxE4A3UL0yayT58zQWrS7yOr3zbQqzYZ9bvnkMRI+
9QZC/PB1hJT+ZVps8aW1Rqp9Zp7JueegbcMIB/Sv1ewUPwu0KXGwT0pR7RhwH5Y9jk4WuU7apxSY
HvSqsIROZd+i81Xc6qzVoHC5O8PTLM324yrh/N7WM/0OmOj2s1sFk7o1+nLA2MXr3Phj1k0Tve8J
W0hwsAr1oI/mOHcCPRVVdMvRSPK+uxg728+3sh2BA9yOyd5NzbTGddrIUiGInA8oewkkiuHqeuou
y9OUVzzH7q7FKSxBh8B09AG1Hlz6IBi2kt5yC8HktnULyPC1TK/lPPF9wqkv2+BbWXsC1qJZV06Q
bzBRlNWdSqoApNfMtbU6gCsT8xd7HClJK8t9jkwe+n7ssJM9LmZf9HdJay3P5dzY9dYQZfId28vJ
2DuJcM1dD5PVCn2d6j4cHXhFIafSpY6dlf0FhsDch1WULF9SG0c/TCeQM9gTSCKwZt2ozzm6sIqo
USY44E1m9lkvxsT0j2ticws5xYm3szUGdojAtsHQW9qjYaibNlabFhttgCGMKIMrM4UpdGXHQeaF
+PjN3T5bbNltFgSY3W2fOG158KLRpa8jbGNflvYw3yip3Ru77O0ibFbB6XCIpACsjRrY2kjVQJZa
REmV3KsIcBbHnyqMxiSJLua619gk19743NVBYn7oCYvepVkKGJ+Hri2ST53MO+ez7UQTDZrF08kd
ai41yHbRleJDb0UZeF0yJua3JWDYiDocAYL7uUkj64rRaCu4qZEUTuWBzzNlG6aacv048PamQyxU
MR5M5oX8JNQ1sYEqLEU/8WrRsdNTN0mCUL+bHVc0u6JXo0uULJXetAiKAkK5ChEKRHxUv6+FLlrE
q9zouxyNNL/Mi6nFgGs0ErFFNMtFcAAtQrGd+tHHbdNHV3ITLXOQbSHf44yHwZJKDosoPIXwR2FF
V/3klEgGWqLsN52bpQ+WHNybcp7RUBoYvsQHXjix3CC/5u2L0veyQ9QieLD1vULR6KtRbdkgyowG
soVww7tajHFFOZQMF4RSg2dxg7bazswc00Hyl+Jr6kAhPgRt3mX7ZSoKJvCthDkx28rsq97D8Dj0
TDX/zPjL1zxyLLgUMKvsJ7arp67npKqsK8y8FzCSIaiQONIoMhwIGP34JXVQWwn9Uer421TF6BwI
dFmpia3aqw6jr/PPgbRwkiELmoxDMEF23bllg1Ti7Da9hn9aT+ZucRAvOdQq1vivTKa+1mioRDij
MJ64NUuNAvqEX6R9RPvZ2wtRZHiwyypxttmgGkzYVdW6YdXKYAz7BJWLjRqEYe2KiDe7wYPKPsiy
qGFnjH5K96vAYCg0BSOcYQHf+GmJ0/RdYQ8Y/jVNamoioT+P29RbYEW3c2v9YKrWvtDpkrRcX651
jXp79yXJcsc5FIvfLgfhKOPZqEcYel43zyj0xRmEuR4NYv0ujq0ZJD1zxmv8DrzuScSyNY9LG0Wg
ImWMvQa+nLFAtWJOS59GtNOPRWiLNr+vvNj42peef5tikTltjMUakb+taxukDCVDte1qN/3kW4ug
hmX4nkAW5U19X7gjY+2Ewqi4mhdf4YxtWdl8LbNClZeB1vXDUohOXNuLA2sjVsYIUK2tAjgwbeiK
O1HTFPt+woHn4FdjMFyPWGJPB8OTqF4FuUPe01dF8Vjh7kljZu5GRrhiLUHfcTUkLDMnKKPYgCCU
2M6PICc93pAqe/3eShVgcWw64xPJd8usdOU61Y4wbKmrtHKq6NhNS2ccFxet4osFkZ/6skGkQIQG
lhlOG8olcfODNgQCvSkz3gAEg20gdO011bIJULxNrp3GUD9j06qaD4ujNIB5nMv3nRcg3VMpLCWu
vb71bhpfo21auFFC64q/3PtY69iHEqExFWIbkD0bokF4K+rj9jaQjfCv0ijo/BszdeVi7G2v7SzY
qmOhmqupW9J+L9JpvNLM49PQU41gAGCcne+luWBpOhSDP4cp0Q8ucRF5U5j5jNmOaHU7mzno7TTM
vIpHzHFgvcCzFWNKVdX2dU2+QXu0r0FGsjrp51spIQNfzVEr0kdlFF193bqlUeBUgrPRIS4CA5JA
UIyM9bLb+8qGoDtp+CcNcdLcG6lV5kdXOTqgod+pDMdKw0ls0EjIjvh/RZO2W95mnEl/K1o1WE/c
FIoeGepW3lXddQ2iLYVZqOmy02kyPCFOijyGm48OjJcGRaIDo6/lRem5HaCybtX8fZa9rG4tL8Y0
TWFSvZrB4sQJdIIpUXk54RE43DYZ4674s6vksWu49zatdirwcJki9WdMmb7v8EKfP6pEVNPNmLeR
cVfZaX8nx3hax8AtJ72sS0PcGHiMz6hOpIgFtglDZPeBYcTP5bCU7XVXQ2vd2lOnYiZemiK7ZDA8
7r9Htm6jnSympH/qUN6BQhO4lb7zWre/i2RRJp8HK40eU9cosmPRTj0EM6MaBIL+Hm73TsKRf6zj
XIgvTW4yFw+NdyE1TL0Pypp4z+jdR3Jv5lghcJYq/3bumEPEDL2JCV9NgO7M3Co7u8VCu3hCgEbG
KPD0xJQoilK0NNo4b7AmyweEkjw/AnZZTFtD6QraYTPLJvju4kv+ccrHVXbCCPw7Tr79TZpZctUu
Rp9sCjzjftjNuLwPmiynd4Lb+H3WJkyDLYwLvMsiTzZX8ZRNxU93rOMPKvBgJeMWEYNUDqmXhubI
hRTaS2J8m+2EnG/IZUEWwpNbn3WlvHzHbL7q7nuB+Vjm+RO0J8Pt6yursztISZ0qjW1iFx5wvJNH
JBRmUr5PzbGnzycyhI3GpP80tnMEK6Hw6Z5IByteuNCBgLbkm117IWbu9h12IqIOszIwp7BLiQUb
o+3gEYggSqyNjM0m2xoyN+hUEuqwbEsIM6EtR8WAvR8xF5RnLuJD2GmbY2jaJQJiBPjkU5FXfN1i
SvWDMTgdoF6W5M8WNlv1pp3L+oce/eUpG7ygReFE53XIrrU8zkvMD4rNzPzopbL7WtezA7aqbOtp
qTMsXSB1J98o1Rp1gwB45o1hU2rZvQ9ErZrDiIR1tvXayVOP7Ife/5Hj4t18Ns3WHpAq6gNr3qHd
EpOoZlNsZ9uydzNx4U1RwIQOuj0C3LVAp+orqVH9rsoCh39mdJKeJL1wgvsxyb3kyhly34LiN2OH
sLXKKooOiz9G7upnZ4vOQPQhTwPuyCo2fwrEdop9XK4k/kwVph0KueTXyTDqL8aSp4zS6WH4aKTM
S7wLSFe/GandDfu2dPIcEceppC9tzPlH9GAmZxv0jGVskLYt/I0gf6XdAISR7JAK8Vp0l9Rwm6EP
aIcexnREVU97Lf942UCsM9wJzkTTRT9NNNaKbT71wfXMC0SOs51MWjNCwqc1q6g8zoJZ+EPqljnh
tyydp7FIhdwunet8ibve+Mxl46pdNUWI7mLN09mbvEnHL9LNMM1FfUjTUepTFMysuReA/PHEbeK4
FTadqpCd2ktv7hN0hzI5MMDmTD/i1mCeLq6zTOwD/BLfo2BWZIe5yHrIpc48dhsRFdzKudlb1m62
AwXKbbbyu8k+AZRvOOWHtFU9nKugmLig4kUiC8Bt9kNg1XXtRjJgsr8TDl2kmol/VLhSG2gaSaL3
kgH95jgHyk9DLS31GFRN6u8Zxqko/JwUzodTsptqzcz5Kh9i/VR1xexwXZlDvamnLMiONupfEOw8
LC4ulWG4n0H7HPcYcY7fYWQgn4Wd8QRW2+B6nGWBdTeIxsRjGdfcOlzcxrse/AYxhyWJs+Rirsb5
2epNQk3vpBPLxm0AQ9Sd7EcVyElvfWUMepfN6RxsFizjr5fa8qGYyry0LkXgDFTxmhGmm1Qlhbwo
lT/xAXK3t6ddbfaOt0HGFb/z0W0baia1jBXjaMlMwDNbFU6Mc5foemLPR3CRRgIO4k4HS1oGfbZW
azr5FMawIPDjewQKSWBsTIIitqhjdlTbpaO7jeo+/upkFjXmgBGcPODsPH4es9yEYYvp87dqysZg
y1bN6YfN2ZQytGEjnGouS+IcZmWCADpdNfRHu8Jm7EcpvLj6bhb+BKlDdKY4Jq2bQG/JkA/fFTHZ
9b4STuLeEp88mML8DeidKkff7Ree8SY0+3+Fql8A2v/X1AEQQ/sN2lnVB16oA1yzYYavVfr191mD
X//OvxBt2/sHNGmVn0DWEokIG5xF/1IDsM1/mNtjnmCdUmGEfB2t+zeiLbx/mAhgSp85kv/WCfg3
oi2cf0CN1nE/0PBff9wbxgzstTf7GwiELywTvg5jEEg/8RNOHTfcSABwNTgjShk1sOFAKmoCn2t/
NfxY5du6HOfH1R/9ARTmS2H2UMmWlAlVrvmC2GMlst/mCMFcjX1WNrulLyX5P6HY2NljrKrdkLZj
cFfF6P9cMThl0FjvvenMHBQDmicPwpwyZnSrVpjEs+KPoR/0ah0S6m7klC9JcFxi4PiDT6a/XLa6
g58h8yL9wY0SXElwp58MDPveJm6xQdikTRoXYSdTDncjlpYeLRrZH1XZpXdehGvfZqmH4mrCnpOY
McXqgxnjRhUCWHrpBapQBJrWKW2ao75fxEdDelN77G01t6E2TehEmWYQl6ysLp6iQZuXuhw7Jhx6
nYGAdJm27xDfKj+5czrJMOjNAr7Y0nYtsqeq+N74STnudCynYpsUcwTNjXI+IVdRI1UlqbIT4gCV
iV2l/bII03nMmXs20OAORyaUJFm1MTMf0MXNXUI5U2yCJocW08vRp9eLKCElAx/5epLKf++tOsA4
D5QmdNLeBnEd676no4zYAVzUIDb0fvD1OubVzv6lECikHSziFJetLJofFMrtZbsE4irrfEw8sWXt
Lgoxdp8zmXWwjDK0a46G0bawOxKL+U3srpZj2w3xZ8Zf1N2YKGfYF5OdjtvS98d3KOsPVoibuk62
trEY3g6TPZClpkSdH6PBeGDiLbKy2zIdHT8cg2r5ESmMisIy0c4zCEbQ8xCFfrCQayYvoVL5iQcH
jpjYuKY7NRvZOytRmX1bT5XNyKanad4XNSdA84sRPu3MTSMzE96nqZeH3Ikd/UF6OJ+FaY/b9H5q
RX9rlilZtqUXmXBRj7azddpUXPs9VqGbJKoZVPfLoYyRAnfFJwoz/zsyPTP630aScA/2VY7nj5oH
iDmuOVZb/iT7iyyria5+l8zxDjeP6XapEs0EQGVm7XbJRmbVDQN1t8OETGd31XbZ8qwb7qcwiFCL
2Zg5YPOejWgC1PYDFZ076uSrbspE7lYdhM+zpzz+P3dZkF4bc0QrsFvXdEgz4d4jbnCgJefBpM5n
CjxuWw2dOyq8JVzMZK73JmUkLqOoZV2w/YAmdZeLA2bdZr4pUqOGpo799aPvuh0Mg9If7oLW6uuN
MSr1GGWW/8FypkU/OMzXPmVFTa6S+pP+gutsMYWJYTQTGGo32BtRVR7ZgDGZfRjUTfNstIP1fTAS
RTMqqeZj2dS+f1ilMZ4rMSsGBvL6wbPHDYB2NHIaUFcOqTnjKzPq9Lcyib1LUbrZAvepjsLK9z8r
6fs93Iw5ephVy7dODDafrhv1vWC+NLgIhrlfON7G2F/aTebRmDYxrNhJWVnf5iEb8YbvW/8pGIZR
HZNkCpgeakjQwyAYEa7q4wmqV58z3p5FSQ35TUQ63gxGJJ1dPjKtfzF3jWNx95PC48FtyGcEciya
47zvrY+ULcMdhlTWrheDT3bQdTX8IUI3dFfTRq+wx6lAhksQ99Bu3aL/RmndP4oqxiXYoTy+jGl2
QdwypQFMiZhAvR2LOGaYjKvqARsuzvLskY9vpR1DnlBy1nNoazl/yyO7rjBmR7kzsN34fe1Yfb5D
30nmG+TFq4YQquaCRKpzoUkYbJrt4nfqMSeyBpvcTl3YLxGqBRtDJJLaLB21c2XKstz1DPRjkT3q
KEy8KH9MZxTr995UjM6K/5cibKggPyQBeMPGGtIphoDqr04G5ty0YSJUlIVuG6wktzRCFKt2HIrc
zpswwKQfklp3cWShH0Exj7kJzi0Yd3h5ky1bEjFX7hWIQ7oPgPbfpcjXqqPRoSYW4twr/esyyGlp
YN6mv9p2lzz4Dsrlm6rIvR82COy0M8diHDF3zXT5w0sh5yUccRQblkhRadPwxD6ws4Pl0jDSAkfO
zEORq7Er2Cfa9kswC3P6mvu5dZNOqhk2xGX3O+ICwDrsamioUUDEqlOvN0Okdu37IPXUlW6L+WNC
LwZydt9X79Fv8pn6ze336Kb0z51f29/0WE3dPs9pe0HLGbDNivpeFmEf5HbACXM4/kj3et2uIG4P
3FdJfJuVkpui1oLRFo/dFQKVxNa136j+60yRIHfVEAB8+84M/NQ1jZo3qZLqI9hWtqJNi2Czj5Ji
MsLs3uSPWqVKwEfVlzYxM1jSXYb4IKJt6bRDUy3/njDVC4F89IcMP58+yrY+ePRDGs3800WpRv9S
DbMTb1zOx53nlPBxRWzAWmn17MPut9UALa4ROHHHbLGt1BpdiWJI+4W8HZT82qa1cKc7pR6oKBO1
xSY4upu71mIM0EmAiKy2wnzm/7NjNa/aWavw0P/O+NiRgnQ/X6TG67/wr8zYdVadrDUD9pG8WifY
/zszdkh/HeZvmaMlo7NIm/8nM7b8f0haaVEzZ4tQK83L/+F6WPY/jOxaTKCjubF2w97C9TjJJ9dM
Hd8mNNFJ6qj87JP+bCoMkDoDcFdRge91bHm7fDLUGVGG0/42uf/631VGd5WRsk/IWAk+ILbSwg19
TJ+eFMX6UVb1eJmUQzLS39Tlmbbz2tT9Ld93WI3G9ioQTBGBnMf62L+xK6ZFtiWwiwintmf8cZLN
hUq1uswrLzuz1B9vcF2KZpqHAB8umKcuD/Trs6IyamCTNq++9NUMrdZokoff9tPdv376C+7KKWOB
BVatY1SieIUIy64Vzm9PZHlznFjTIEInD5o71IJrerza6O5R64ZaX9T1z0ih3BS6g02aRtdsX1h9
9UTJL/eutRRnJItfecPsXZP/8IJxuTrZOMATMDgGfk+GveUIShgZm7onZMYD2v9/f/hX18L9aB1G
59OKk7XiKi/LKtMi7LH/uG1aPTw0MkcXXRbGWYWiV/YqXWMUMOkEwYo4FQfXKc2pWtMzQyvZubS6
IHrwRMxsXW3UN2Ic67t8wWItMdVE19Wit4utLBOHABXhaGTMnJgjwEdtZ+MVAOC8d5voja5Q6/Ze
JYZXayPkuzBufrkZZj40Hjulh+G7QZLixG1Ie314+872oKghKIm+A4n4CUXJrNJBJj5YlGy9icpy
cR9y6WXniCinFJH1YVDKw14eN0407E6CQxogaVLmMQMC9sJo3TLEFxmAwPd6zroLp5wNmI+UoDsE
x+z7v2+sU0Xs9UXCu0HMAK1V9tYpOcR2G51hxMBsS5fUDYCtJ49BbJZyPyJxdwtsujbhRrQ7Bs9P
ZvT0u/5YedLqwwEK089R9PXb3zq7Dk1UCnwf62/n5beN/ar1UB4lVpYiep8DDm6b3i/PxJNXdrkv
fImNC/gK/Cf35SpG4ujKDVAsVZZRHnW5WKRuabfSU+CP7JEVib7//V2vf+JJSGa/klej88qVE5ys
GLWF2dZpLMK4Q4eK9xhv6Ja+TSuKC4wPilYvlDGkP9HcPwmT2k4tiZM5NWHumbtmKRiABqXZv/1Z
Vqsdm5Pxa8WXb2/BQc+aylZQFDfjnVWvluDt0r5JCe/fz8LtgqMiQdo/pe0Z9mIVTcnNQmLhHnCZ
FptoNuqtNt4qjr6+NpoX6HFzNyOsfxr0qOgaz1AUHqWco60/5TS6I6rkv7+2NWCcbAGol6QubLgA
/5WTsGVOXVkqU7FK7w3ESToEqZXvnMjb1p19n8xpCmbhA4wEZ8QHXrlBkI3FPptnQ3XuNJT5oitQ
VQfLclcoinZzuR+W0dvYHbYdf3/I9TI6fUh0tlHyQtpcosvzcm/IMpdq4ioPx6zeF4OHhqCz1qsx
hKvKvmz7YT7zWl85Wfgk4fIjyXi4FU4CqAhqX6lCYaIzOzOOjehwoS7+Rjn1X1sEkHYlqxKuMXh4
+Vy2V7YLlbEbimp0jnXkJvsB6PAd1bOz/fsrfG2fCER+XRiYq5DWySGO3VKPHlwdRA+9+ALVN/sC
kE4fcGqwrjOnNNDMz4sH2tvj3mxc88zyr20WoFVMvxE4Ats8edK6Vm7lKZsYUqI4IA23uPGCTt0U
OK3+B5tl1UTERBZhKPi+L19qpc0F6Hrk03X6doqqD3Maddu8W569KLv24+GcQtn621/uTvQuYRTh
jwj33Fwx/9/TSKBFO/VHbHJ0VDr7DJTjKk1bsfv7B3xtFezi4HOh8LsS1l+uMtFvGqKIejq1mnIr
e2Xv6yKSZ4yt/vxO0FY9DGogl7qm6Z+sgptFtcQxzJyubr17qMbB96HWCirSspwpYE7GSNZYLHHp
csi7MROwUfp/+UR2nnSrmDHiF7WWZhilfjNsndRZmEq1RnFLQ3mYNomvUfgpxej0O8H/hIPWahMM
0x3TL0vEnxJ6QY3xq+5hE9J4n9Qznfxi2eOHBJsks4YSbqpTlp9zoAnYA5Daxn0ddOnNDKWduTkF
igS0bLQ/ggRVNLw0zRFHZo7sFKraFg/RjBEUEnwDbfaKhi7Oc2kqvkWepZ4dLsVbgOzssfa1Rxeg
4VfzewG/r4RVuQ9JJUjpVRFUkPsqr/nczMEIOa0C3g0kbuSbxGvjy0j6Sb5lW4Ot6KA3MPONXQG2
54gJ/ZqidP23Wc+t758eERRi+kcYa5zKMxYTVlQJbKhw7IV9Uw7NF3+2oou/b9tXNpSFoBVZxyr3
yUTCy49Ma6DupQV2lI35fJU5dnX0myDZtGXRn9tQ/FEn53D1YuHWpSnLUTzZT1mbml0tUjdcppJ5
SC+nmx/NIoZ+MBfizAXxSpqL9hdTI0gNexQMzskNURV2UuuCAgqatfyuB2GlEKua4K6bGl2G5GYj
mGhQ4jDbmVAEM9+ef0CDSA/xlGfv8ZlUZ171r8z69AVgUYYxEVcknKeTmm5oVjSWFHelexSXcBR7
yFROKo5GFlSS3lzh3yC4zGtxBNyqDQ2s6V0PsO0g9r8ANMbwExj4cyrqsEIm0XtYoOb85vjM90b8
lfEJdNWAal7uiNq3MQ6YyFiitrS/9a2FEkhjiGeKfvunni3vXZxkw8+3b0OSf6oRBwlzyDQvF5UJ
lMuknnk1sHOvy2xwt6WZWsdF5ca7vy/1Z7IiLTqG+A8yWeT/Eoj//TrIrSyjvqqY2kwoZE3ch0Jo
Bu+7tP45i+yd1PU5E6LXzpjPIABuuRQg3mkgdaJSlFm8wiWDpnkIofpTwd/cLNCx0zP7/rW1gJvo
cJJMrHYhL19kVQ01SVhPmm41w4WlDW8jtNMg5LwM/8lSbGVaeIBznLWXS/ncdpjJkbIsytJHWq/s
joLKTdEc+Psne/Wh2ItI93F+mGl4uZJeyjmbR+ood0aZvOZepRVn+dm+pjg9Nzn0ykX+a3piFRVc
bUZPwhTqrQFtTwKSlk1+M0/uAklXed/+/kivrIIGOfUU2p7k56eFjhWX1mhhooJwgVXe5l1er6MD
Z8egXl2G50C6E2lD/AFevrnA1FlvaLbDBKxxUcG4vfbSyTy+/WFW84LVplxiVXGS/xPIQMBMhyOl
+vE9hJp5C4nHPnNw/6zfKdaYEHNXUBns9uRZBJ1xePwGZN/E4VJ0y+fIGu4sCEG1AZTy90d6ZcsR
hdAaBajm9pAn5yhbMDueHBbjgnGerFr6+8BM9KFL7LcjW0CpFO+MPiKy6q9zkb8HpMk1YPRrj+Fj
M/av+2XyMbLtxzP1+ytvDzrAatxMLreepJeriN6CdrZQy/iFKY++0Q1I107ufato5NPyts+ApX9M
HrIXQNA8DM4Yg6ISPblHpqCXM28LnKmp8AuXVW4/CstVlwaA9PulsZYfab5Y99aco30+xsN4pCfu
Hv7+HV97bEaggBIsQC820MvHXhyYjxEpHrKTDUSEzG52MjPsT0olyFDhNHrmKLy2HpED11WOA87y
J/um5IxExcJTQyuoLjocQ/aBTpKPaomWkIBtvP/7872yT+mIYKHH5Gyw2sm9fL5uREzd+IUTGz3S
BkNgba0xRuhTek//wUqgZ5CWPMk0rv1ypRQeLBzniVTZTNATwGRtE2RjdQXtQr8ZumA+WEowLbbq
GodfLsUsqmHFLme6Nd273qnkJybalhuIwue6NOvnP0nJuLh+GQ8EpNmnwV4kdpDZESt1Nn6HzNTd
+xIeE+Z8NGloYZfb0ey8I01WeSbAvBKZgbjAuGCQsUFPE+9OTTqnuSLCMZn8j7wDiCFFspzZHq9s
R3dtcvHLVzF5/+RNAmlAM8VPNfRhGIW+sTxJSLhQGZOffaTfHqDBLwiWAAgYJp1iGK2zUJjZxEwv
zhrugsDciCRHcCUz9a4BTTmzTV57hXRa1k4iLS/aeS+3SbEsxlrSiTDv2ukDlMjioIfk3Il+bRWG
VDnSeHNLJkhfrkKyVdDIZ98XS/IxjzzkRhjiOVMbvLoITEF8RGnfoVz8chGMLOq+jahD6wKzB68Z
xLsODsPu7UcY1B90laeBYXhy01S101pG6yOWRzV7cFPPvZwYP99iWntOSf3VByIIwoxESJ075+UD
Ja7yyM1I6JcG4kYeT8F1NhjnjFPWH3x6fMniwXboxoGxnkTbrvNz8lp2wJTW6THuRLzze1nvR2dZ
LnRbI/RnNNedCQdnrr2zCMkrq5O9kR5wbwm6oS+fMU4t6GnmyBEuc/NT0cAAToeAcdgAxa63fjkM
cxgr/hXqMeo9+XIwKuIUkjnp4ggXojfS8T6BuHiYnDE+c2P+GRJXbx5OLyjcGn9PbhTd2gzGiwXE
2hjbZKMdgZ5S24qvqTFJFY4rWO4zykzLcP/3h3xlZeoWEmICCJvUOjnPXbssnuH3KF76IjrAaMnu
81r4H6lBmdtMaifdke2l22W26eL8fe0/71EKQhIw2jR00ekRvfyWQYWLZUl1EarUTjdrYXZUeRZf
zLU853Xz59FAZpxkBJ0LGK385eVSUeR3onaBtKQxyLu80ogYKcb3/v5Ar6xCBgYhAECXM38atgBZ
G0Z0eCB3jrF5nwW6moF1jnTw6ip0MdekgLP+C4X5rUXv18lMYCYdtwtDHb22XEJHleab41bA1ieK
0DalbD9togivLh2rgQob4ee9c9QYhEwsx5u+d5czgXi9EF9GFJayXVB1F8ueP2CjObEZmQUnDwtL
VF+LoQKFTNTw1Y3S+ZbZPYSlEtt680XGojQlucxo1BCcT3ZELIMi7iZATtxSv0zzksLVNOJvb94R
pBlQUlYyNUMZJ+HKmg1kP5jrDF3K6H2/zO6WptC8/U9WISRTPlHzna7S1F5uZIpVuipDksxqoDCU
xTl/tleOKwFqLc3Wziq9mZdvrOf1JLmC8EnbZNkBWy4b5GOWDciPPhN6X4HtiIYUgpKUhgz71Epc
0zWbZ4CysJU11MK0NqsdM2MDPFUSy4uJG+BzqjEr6a11slLb5Q9KVezN28lF2tVIip3XCY0lXoVc
kZjdN+PEa7Rm1AAyAJHTPw2bXj27E/ly6OihPLq1RGPASs9FrT8zSVbhPAD40C7lZb5843HHgGGQ
cwZjGXuPKKFXl3m/rPa/zOZtuCDTt28kBiVAStdFuRZOPjHqEUHctHziJvbMG1046E+IbD7TUHkl
gFET/wIUqNqc04YKRtRqWFIPX1RZOh/5GU9DNJw7ea+A0WsgFsHKsgHDOpUEmdgys1BrF6NumOzH
jPrCW6rmvu8UvloyjavHMmdysyur+obJ0OIHs7oDDPUx62+ETM5ZDL5yfEAaVqYY2BMQ78mWmTtf
MLAu+ZgUlx/cUuJm4LXq3lWLfeZSf2UpLh+wuzUcoNV08hndgiHLzobbkZUquS2zHvH9uYC0vkTd
mYPw2lLAUFBRYAlSUp0shZRH9a8WXFv77Tffq/rDnEXoYTLYd854+pXjgAUf3bEARMUF5nh5HAbY
yxFEGNANK+qOLU7r7xJDBthmeca+nxnGfnNYpWcK0ErMW8vCky/GnPFE8lIiHIo92y6r0/TomXN3
JtadvkHeGeo4tEsdwAtw1pOn0kq0SnasMg80glqVeFvTj9OHrDDeyiHEq4r5g5WNg7WRic/0yxfo
zbT9+ryg4U3XbmPkZrabMIw/kwX9UjX6/T5flwEKNkmzLDrO8iRxxkZ1GfORZfw8DkUpDjn8YydF
/Xz17+7kbgkQVIYnHorM2gdu9HFh+mSJu21pv81lk4O2/haueFB5hF7cUwTFLmZY/pLmraiKeuPE
rs01r/xDHTjqjdtl5cjxfkFRYGV4hM+Xb1d7lcrLFEaGXzbZZeAl/RWqLeda+afBc12FXgON1l8d
dvcko4CX3pYpR59xBm/6Yom5f2zd6ultO59FVt2AVeKNHJOd+fJR5nZImqE3GdUJJDKZuc34t0jf
mrYA1eELR5OG6hvg6VSQzWu0qia9MuEdH68B8torUf0Xe1/SHamuZf1fak4tesSUnugdtsPNhOV0
pul7hIBf/218v6pnkxFmvTeu2V2ZN0MgpKOjc3ajp2ufRV7GjXkcgBAk3KwQfNHf/f42YtvnDE1t
yYARuvJeAtH42uda9jqppQYWqqhVH+B1D49pFehvEhPqNykuE/TFWAKPmAjwNShug5ANU+5SG08I
eAoMGxisOrJ+4LWHFKpD0FKGb2TjxjDL8sOprEJPi6vuBCUqDdYZLfpBPnLgYlcUSY72/NBL72OW
cpMdhyPnFT2IHxY3jRJE1rFVWhTHeBGi9jlE1awGIgi7SGF1ZdRq1L1ITYA8L88GGnoV66vGxBlC
vAwE6reW6llq9H2eQGleVGPFKfgsBV0uI+MYetAn4OHogKQ0PA46TQ/ZqI2XXhZK+C8opXKMsHFb
B1T7RITuTTNBP5Ufp8bn5ayG+kuZ509lR6N7MsbVaEKHIN7nTS09wC1SeKuYKLeGBhkGZkBmJ4eE
NVIXeBEoQ7dHQpC+QkiiHpwwGmT4NOgDFITqJEDci2KxTPwknSkDDTK70A1IIleORAaIl6SwqAMz
DXpqORiDakFg36REIFIBbhU+RjUbOrNRq1wDcrLPtvmARj6oCDE88IKaghRRcRyESVS1Zm8VXwkX
aWQ1WExRoNfGVBT6g6wMauvDEnZ6jyQVkLtWH2aGlCo0d0qUpSe5byowPIIhf0baAvFtljRlAKNG
CCUaXVpp0ByIGwbKMsnqvchJ8gXMHvA5BkVNLzz+G+u86yGXyaViA6w4qSEADuYNDCL0AOE/Aao5
g94HyPsu9NnwxYoSdAsj5qsaNu+1qP4KkkK89EHclF5IC/wfvVbCirPWlPp3AfvGYA9k1QRhdYmT
HkI+5QdbzJPgSavHPvA0oYrOWk/JqQpSyU9GCk+9SG42/MyBlwCbMxiw2K8wtFYvKOG3qgEIappD
iaRjEPKcpAQtIAgKgPkPWTsQWzUhH9wWlY3f/KCl0HTN2YDFTkgMSfO84X7hbEufUz7QofZK64ya
BJAPGK3qETs3cGWtrBoCGyBYaXWdb1A9C0dDFebyGG6/KbSJwl67QIMsgVwU/v173w9Z7k4wId0V
Omlao+7Ajs/4KoPdjCgn+NxJI8BUgtTD727ItF+sA7LHTgbw0xypSqKnAcWGwgqYWp5UAG1gysGX
DZwBBNhSFkZWVDL8IJKKRjbaFdOuIXE+HIGjUN+iJlYyi+mFUoPZpHadXXYgQYEhVRB1l4gkYUel
bSTpQcmECVL9ZAyxGeqsC81CTnLo66s6awzwa7TiDjiJ9gXqFIR3QZ2IReBxlD54SaSWz/fQN2K9
2XNN+tzIBOrwIQiREIKuY9CH25n4ahRpmZBX6IdMjqDHQ7kr1DxlXgXkIaiF6GW9NFC1gPWXNoL+
2nVFL5ipUkFzoh365pnyQ38OBUiBGTrmwi+kBAIFY9uSeFMpFObenRBqqpFXmcwMXkb6DLzOrH4A
5UcCgQBIFhJDLJoOIIoJqoo76IrkgpfEtNiVdQNFsr5L8PGmTH7Nc5W/R/xvX6suR7eESLXiAd9X
zfClCuifHiIajsSpNUxCI5EnuFbNBoyhzrpjMiaKYg58C8krQEfxlwqIHZcoTsNTP6oxiFydOFFw
e7MgQ92bjJ3BsUb5yPTSCWUtexNiOTyl0OYRjTiHqIMLuh3mBIIgBXQBcD2A3UQQyYNVT6QMzVyH
Ha8NqU7p2OX1rMGTTQxK0CNEAqBZMOqQcgfYN/RyrYVluD2Ty0QfddEshHqUXrCHEWogd6FAU5BO
oobIl1ruR2IkSie8gjAnvDbgjPUbKiiD9KZCYkji/T6Q0OqsiB7sR+xfZrKiEV84oQdvtRFjUTOB
+EwhtA8JjRPqaVibtdS0cBtSOBWTLZAcgrx61t7FWpS0AFmkFF4eLW430NnS9dRmEJ06NPrUT5bS
Ix2FpB9fD3Y9FPKBi4PqIZ40KPIBCKcpGxVKIn8A4ZpqE7J17D4dB6A1nmiR1ZFfd438mOdWVTXq
hvJS/jGGTTUaQaRMmzTtGVSd9AB0jbnRJNrYGtAWprjPF0YlcLjP6gFPYrOXhHQDgT59MOtCJL7S
cbxgFXzNv7IJUcBKuJH84iIg9/F+0L6p5EDsjFAZxMFpUeyeEGVkIHvjsh/fOL2MHjOl7HKDSSST
7RAbCrXwLIshsTeBWYrlk8VwE0Il/gxtqP4ONGhI9wGSH2wkjk8hnc4TPLsMdj0kO1W1+gURlRLE
d2BxCkuVa9w9ppzGftwRFjlSnbcozsoRhOowr0JkDJwOGwg2BKlbszSGBmnMJhtHWANHIzIqHjSB
9HvCpznMjEYVKqk8+k+KJYQIGTb4dPxdNcSQs4lSWsngWEsc9r6uTb0p8wK3TYeq54xqqmnmKUmk
301BP8yU5Lo+0GxoDrSDxp8pR1NgQ56m1E3Q/tQTFvo0mEWBA/5dkKANaMqo4veHcQDKb98OoCgf
p0BgYH93kBf8kDOF4xw6VIQ/CoDFJnYLion8OkA/D+Yuaa91R57KMB7UBazSvahGCWTOJzVSz7Hc
IvbFqkpHJ4Kgrfrciukw2jKFwJQrNhkwVaAPKsmeg1iZcNZ1pkDJPg0i0ceVp6R+NIH27ghRzBQn
SNqQmZwOkmhTdYwewVyUztUE6aXRGPJIJl6ZDb1gB1qApYobsVK8UNDWP35OiP+6pEHdEkK+AMAD
2DHjyb6nkNDMaRHOR/AYRlbakZgrZiqH6VFTWXj6eahlfwXZ6txcmS8tAP4Dkf99KMgMADciTbKh
AWWKc0lVLRWKC1iWnT44jRrQTRy2ot9W42S3LS3sn8e/+qoALaDANwMhlxgClkJLN4KCkUHiSXfq
TpEe60AaLJI19Urb46+7DF4V3Xhc6aEKSpDQfn/VKAWhdySAJZcBGsDgxI5uXUHB7N9+IZjHyjzI
P2ivAOz2fRROhfKQxnByiW0JK0oN2RelUGWsOr5eufpe+XbAc871AsCY0G1YVEMmnmRTNwG+m6XQ
pBShtVQaCpj8EGZQpQMCGeT3pyra00SrNkwJyPvPr3ptQj+bOYA8iCgALcavEwinIoUDpJwEtTuO
QWUzBW3Un0e5tkJAe0HVAtQhQJAW9/uK5hNuUpB04JqysuWBg3ephsQCbtP6v71CUJxHMwMdCECp
/roiNp1M06YggHZAYdGe0BXYq61C/vz8Qn9P2zwKeA042VBdEhY3d+jGIINBxcmAREZpiD2Bb9WQ
dCvT9nddBOozQHfLQMWAhIsi+veFGMcE6IMQw3BtxqBfqEIvArK90J7L9R46LhU5DO0AFf6xHw5q
LnB2OaYp9GgBNvFJ28NCtoRQtMZBRPXnCZi3wLeKDZ4MVXaAItCMww5ZbJF8rFu5RAJtyJPKv4W9
AnssHMAODZCiQ1UU2D+VRmtAkGvTLgAeNEOFUKmVF+XtQB8h9FliPnAOF2abQzGCDZG0Es+ujgLO
HVpy6PWry0bWkFLWIXLKBi1y4rQ5e+L5Ya1h8XeJAdxUFGbAoQbrCK+z+LTtFJNQxfkA/D4UADqB
PhcldAUg5qDdlbkw/PNS/6cP9V+AsnxZu3/pQz28xWxpd4B/8A8FXhDF/wYZCgwllJSg9yRjh/0j
DoVVDatp9JFQAZyRPzL+zf+YUKv/jRbE3IFEM1qf+bj/S4GHpBSISAApgfaELhZ6Cf8OB/6zl/6v
XcbN7U0Z7VR+sTj6UCAcP/DCrtoJx2FHTrknnlLI+2y7R875Mhunf37tK4F73qnXxph3wZemsAzo
2wDcj7BT7+ghuhjM4V5+/uUFuPBfj7/onWvQ6YDeBH5a2mnnYNc/lTuI1PwKP+QVLNM/kJtrT79I
BBhTNFSwWn4HCFh6gjwKJD/DpLET2jR2pykQVMn1ZthkDNbYYtv6FAQmj7X84EAtOIKnTC27OYXa
E8fASAPnoDZqpYXxYYCyhNhKsGHLc8Uba8jtKYD/IqihrdwlhNhMFltrEpPKpkyY75wJ786wUwv1
Uc1Wq4AYtGlri0ZR5AqNSp6IkMFRryPhu8B35QcDB9TUKkX2iprmFmToQTnlcT3SRyhpjElRRwCA
Vo2ravm+iAreFMJz1xZep/eVPZ+yZpLRyCtwPBhpz9U+lpBuh2BsnPiMf++IUoIrEtHkXgSHagYc
kvuwkWS3pzLuFTW4SHxJITqcyLmbJwmEEnWxfK4TIm3bpqlcsYRyGESN00PQZpyFqif8q1PxLR0Y
53ZQJoQSZyvs+0gtcHcdYQEexmyb6U21g7RdDD3SUDJD3NExRAf+T56TdzRjS0uRMxip9jVuqxEX
+imvFW4sKfVWjALoNwZQuQEuB1dqEJwh4dRA6DsQUHqS6pdciPt9Arl0uxDytcRy0fz7n7UKkOH3
bQAB8j5ohlrYacKOk/extoWkfVTDcrclEB3dquodi32i+yEquz/vj/m0+nvtomH0fUg9KKDsyWVg
UEgMzo9RL5rdmML4lVaQ0RJr0YU6T29zEcwd/5MRQTr4PiJFu5nSERsSLwivLchkS65ooVz2889/
Irn+fiNUzr//vjZqYT3OG76Bfi1ktPcJtYdTjtfh6AaZSnKOii1IdwYKZjWMyy0BLk/xpoA3a39e
eYY5uPz9DH+D6FUCNhCnTztSxzaElx6YlttTC3XkGj7ncmwXuX4AuI43+CS1Uk17gYIJPFWbqdw0
kwzRShfEHYMJT5GAugiAK2inReaklS+Mg5Nj9++Rjv+14ha5o9ZB6wvS2NMuq2E8398xOCnIFmSy
ccvdKr+p6K3MyPx1r83I4hRRSSipkRhOu6R3m+ahZ0YAZXIUvp41FNtVR5JBjyN2GW21DYSGYrBX
Ufl51LhTR70mv6/SlYvqrQW/OGpQpi7RqOBGeASXxKLMKkBwqH7pAmx9mf/z284n9tW3XRw6wJ/o
gpCl4262S023Rzj17UY4uimHdN/7ClzaYjP3qVXCZY23QwN1SWcwDzWMCfW72oGx72xHfQ9XwAMs
xESDbtdO2gVG5V9ffHFYEQjn0aTFownE5XkboBNBBVWwAHfMKj8k6K3CW45tEpiWxlAd+/XzjNzI
ItAI/74rh7EsepRNpl0IrFyO9h8KuXBVySVDaQ/lY2GM01YlyYo4wM1IuggCLeXyrqUVNiBczyNT
gKlsCmNP0ZI2IVwTf36pG6EGzMHvLwV+ERT+oQK/U+ErSy9A7+9a+FBXXnCvPxZevyHwZ4R50R6+
wv6a3svnve7KViLLkA3uOYBv3bTjCW9MQFkmx0SyG+Iw5ATRgTE4sSsPkW5KMWoFfGoBJExgNCiu
rG593rPXHmDO4r5ka9DtL4ugL6ddocGikGYXwqsH3NsdoiQG4eGkofm9vm3K1zaEeWU9l/tlJ1M0
t45QD4LKsh3juyjM55PuLWug0tgpGoyttmnxokvwZtdHhx+mXTW+Tqi0IvW1gFx0oqZ3pB5+pa1P
qM8lu7Y8k+IB2tuoEUObF+35csNVl5Y/0wRbSLqLlSc0ioxwujC+QVH5TsQTlgKz05iHy0F4Fsaj
BMl4NDWsMX5Hs8FsYVQ3PaP4nKXiVsjKU1KGGzAZtxEXOEzrbKmGzxFBFwBqndEplDt/aJkVFxrc
CPyw3XeF6g0KbIzZGekOG/YMMg5VwPtKGeNDybC2VO/VQYBWMX0depzkLaqsUqccJBa9RwLd19Ua
+O2zwnftUy22nU7iDGglhF3ixlt0EPh9thW8dEtjszgJHvwX38g7vxse1aduz+7FXbsS8G/FGbLY
gTEdewpFRWx47gSsXceMQo6Nxg+AbbuUIqCYoT1Bph8zNdZ7XnodxLuft6VyI8QvERyC1ukEogvT
bsjofpKgAc3Ltg4JLwNYf7ch/WmCwLnOYA7UX4oKdrDgZs+q+Qog7vQhbOvnVj9Pw7Zo2tcohXBh
PNmD9qBAh50mwVxcgCgAMB/8aLTUrWEjmkN/tMGChPfFIPcuDBsAFYGvC+ttEsIGmCV7xNxNAiOH
hoNnK7RQtPQwhTsB8otNYwQptMN3vHoM4DAo3UcM4uClN8oAFsBJjopIWKH5nq4xF6UbCYq6+Dpq
Lw59lIfiTqnRBzHY88j5Te6MLv2AW5Ik2Fi/Nkpv9T3pTf3lDY9Ijs2jaGSJCfJ9f0mM6YCOMmxk
Kugr7mTNbIkZpg8/f8JPstWVdassIms+0QigOE7YDRTmo+MIIRS7h+Uy/GK1beKgu4Cusno/kcfU
BUVfGZ4Q4iuT/QmpKXrwApN2dXtXqkeOmuqhWAt9N1f1Il/i4W9L+g6xl0KyFE5Y7iBYkQDYXcEb
bb4X8pcu9bDCDF3dkAaSAwqsFITM4PIVFOKt2LvIowKWx7AAQmxsVcXMIY/IdpKwRsUQ59e4Mu1L
+RKYyuhVq9fiLm7QxhqSaPIayBHZMDMKjKTRe0frA8VB6y02m2QQN6j1w/9PSHW8LcCKqYz+vZhh
sxMAARwBzg9eG1A4Esg6VkrIIH5ecbnZ9iVUo/WZGdMJ7RkSIwO2HoxP3tF+i9jKVeDW2yyysCnn
VNKFmCskemPvESQb6M4Y6fD+8yq9eRIvcqmBAO0tw0BkN27YQYfZtwIrd85sEFcF+4P7HTvRpjBX
BvteEfzfxG3J/wVgRZAZWra7KHSpELwCkGLz+R3urAE65Oxc6KCVdIBjGHKzLZMjYAE/j3xjGpfl
1ThiQpWNyBhreGBX8P6Cbht3bIa1O8gnLuvKqlvqKkEVpMzCgoy73K5feZu8vLc+s+D3rF4c4Cqw
3+EehnhEvMI48fDdFa13wezg+0t/pb+Q7fz++UU/WwDXHmSxudS+AgMt0MYdVFdl9g66ilB68AiK
X/NLe9fHjupqW9Si4UPeuNwm7x0AHfccvIhRv+HhgWgIH/lLH3otLLY3dKXMLd768vOff8m3+rAJ
uV4GkDkRQkNPXlNy6RInn3p3+kgBNGBQHNHrd+lQM1epNhO14sgVR3S0dRQ//HYAan8zRfao7WPR
yNcoVTdKa8AFf3+uOuSlhAKxAP9ixAPujTo9DN/FJxXZ7soXufXqix0GRa4JOmIqFv2utbsdO7f7
2kXCVmyBkPL0vfpcnxIPboMmNWC1dFFgAA1F7ZW7oni9LonC7Pc3ROEVEhsjIsiYPemR24mDUaaN
ocgmuseq6E4QxhIy2PRA/o9YUfWeeUlwmQYL1EnZJ4HR1ndyDPMyxWrgVvGL1Cbeha7kWNKt2Vmc
4oo6RflAlHEXBLytcPvu2CndYRq3DRTO+8eMoGplS3C2inoHiI3QhaavMsLtxOXjg9QYA3y9U2co
oD7uKdKmVaEjDh5LwftZv28VKNOnEPE9tcUhatBdKdd0lm7t+Fns9euKLrRC56T5wRsHrVk7MRG6
rNlLGzrVFmKY1RoqzMUDC6LtZuhnBtDvlpv6MIs2qw3uVAZ0fN2VNXbjIy+BnBBVUMZMKJAuxtEW
8tCuRl7yyec0+Ad5I+NNKh2gE2wULLEraLGMDXILmGsBCgD4Qwh/ECdMXieK02UsAAzKoGgNMquK
m1hvTdId4zSTBxpqJRx/UgCuRCl1cf1KOa3UWDNvO+QeaLc5AsoL8BP8BasliwLYBjd4YhQHXnsM
oZysW8JaT/qz63Rt6EX6AzhVzdMJaVmZW9QTG3ylaSPmVgnzKYiR+yUKqIZuBpf2KT3IXuLiNKJG
kaPOdQxtCZLsk5M8C9uws4d7uMbf53fQZDio3KlKnmCraK9bm2MlXXvSRSjPJUCKAoInJa5kTRbw
rA7UfExpg2c+plaxiew1VcVP0clrYy3is4yKdlJQjBUfOl/eKFb2UO3IJkcqwJn5AwhALrqEG6C4
/PChMrmtDtP5nxfvvGGuDb0IwT1XZROYTWicbJQdKijwik+8ab8mInarbLMkrMZ1EPV9jd/X4cz+
MNzDX+6J+6OiaLRPOVSnfn6LW2n1Etofo48Fww0Mg+qQmkNf0WLNpTW4/eBR2MP7mmZ1W+SiSPVV
e2XMG8Hz8/b45VQVWDm0sYgxgcTldUse7gDkVe4VKTOognrkMd4N9XamRsWhmf5aGfXG3XQpVJDT
gAe4NhB2bDPWqEWIoNWpVhg+M5jeQ3a8lN5pf4qVwi9VCCUQo5ZO1K+ACsudciWh+MSOXFk1ymIb
R1JacANU3HflAAamW9QbYIEF3UHrqAKwxChx27VH7kM88Q5s+Dh4WIYWNYjiyoLd7JPe0fsPXjyx
FLAyeB3dkQEiu5sKgOcc1x2DAesYeWEHgJsxvazM3HyoXXvoxY7uOJhqifMuk47BY2XRN8EbX0oQ
Ig7JypK4sZmWetgi4yl6rBiB3AnWw2DIx8DIVkPSrWrhp3relwWnNdwQNvNeTXw5w5253IKN7fS+
ZLV7aJyheAe0vok44Y8nmI4OZr6y6D6J2NembpFFBY3GRD3FyGNmwMzgIjn1GQZfm8Idvcpq/MnJ
37KTsAXG8MLt1VPpxo+D2V/0DbwXDlj9FnPCPcp3fnm/GqFv7b9FbtUVcI+eIE290++BxtZQWjmo
Joq0CNDPvFX6CJfHtUzpVqq65JSJPHyByzmOwboGlEvV1M9wcs4twU72azTEW0WLpVs9ZDI5NR8w
SG+lNrxRHdGGUbtTOYVF3MkCEs6IzqPfbWWr3nVmtO9cfqucRvc1s6vH/2ybLGEpYtiofcPwEJKT
erz9R3N7W3c5f+20u5V+zFiEr7kbE3magbcq7DqnNub3al3VIg+wezV4C842yOI453e0sic/2edX
1u4nPebLrgmzAZY185eLgl8VcaZ2j1IErCQsEWaDEgC4FoTxuPvIBWMLjt7RnptcfeV0vXXBlxcx
J+LAta/mfCe8lG/sDIWIj2Gneeo9/14+cG7rTBd6n/35+dPdqr4spWXCoB1JI2M00SSuunk4AzOP
xsUZjDekxYJzBE3nGJoArlu51dqX0ArM/29OAdO18E95+mdC1xEYEJj5/lVh30Jgko2xU0O2cxOR
wF473T+5gNc+4SL8dGML/P28JDunQc3VnRyCKzxv1Hbj53Z+zqzWDJ3WBrjBkxzBAHICW+YEiZ03
0SqdAMmjsh+2aJHh+mWt8SSlG+H+s3n3ZWXJUgwCyz/blbcLZ9jRC0yBNiBr7Co/9nIDHtMuzYzU
bi+CgYLoR7kLjtTJd4PduR5u0j4MkFzRGXFKMC/yQ0fzV5bCPDXXpmxxs5sy6LvJ8yZrnNDrd9Sm
7uRVdury6BcGlr5vDvFJfm7MbB+5qkvM2Pl55M8c4MrIn7P1ZVaqLI5I0qAyzOsHmqLebQbEqhMT
YAgAvosYV6B9BYNz6og4/Y96s+fKE4PwEsoNF5Hdh7qNhroGz7ALrRzxbhBMVCKq2tZqB5rcVps6
ce7IyUsNU9PW4sGtVE7QDiG6N7QemFe1CrNT9MX/0EA0tRS4losiWTk9hR1AIcfwXNY2DKCbNbr6
p5bNtTeeU7UvbyzlwEAAMyjsqKk42bF2BQcNIps+hvYTqk3u4MoO7wibdru202/df/8C9QJNoaU8
hoTYqF8akXsR8J2p3VuiGeEQjBzABYw/ArrBrVXZxKjc2u6sx8GGuZoJppdx//PnvhVel/zdqo4T
+ITiSYTjtGO26spmdaxNwRoMgLSt0GS+dlefqn2yXxnxRjnxM0n5Mt0pN3B5MI9YARXOa8eE20zG
SQrcqAUExwrbNwErLzdBcLOJDJTOWjC/kXB8VlG+DMxLFegG83cuDWbnh3RTmr5yZ4tWZt+vbdxb
JZnPhsuXQSIaT6pQYRCwAtBA2k+tobxndNtF9oQvLGAjnbhD7w+JoU9WA4aH15/Bj8jNGJDri+Cn
2YtUWuhH8qcAPQWngA5yeCDsRJGXr4J6b1xDPhfml8eEu3UWgzMm7KZ37nl6QGML1YzmNzorbz3g
CEcIUkeTMfrSPfPlX/XTyre/Newi5xN0vuqa+duDLH0ePyarQlCL5lAvmMCo4VhLUMgDqWVtsc0H
9bW9vYijs4IA7BoAp5pwav8JpHta30FfGlH9TqEW9hbK5kbXWHJk6Q8rL3ljzCXAXOyzNoFAP7Lt
O/2I/lreOtHvvjMHg4ooFhnSK5SQoB5xHmFAG68gHm4NughijAOrdmgVoKpmWvVFj+Fqnaypqt4q
A4iLnK/jklRrekyjIsD6whD34bly0r18zz83CBaXn2fuxur4zIu+LMphYPBRz1Rs0DHTcCHn4OQV
8c9gOrSmTkK3rECbqYZkZbhb+dZsxvo18AeagspUgvHqi0aN+EAPwaXeJ8cUea1FHxqv3U2b2G+M
+KP1RK/aiA5aL1b3GCFv//mVb2WYnzX/L+8sxQk06SgWC/tQLDBgM0N6Tk4gQU4uGK3Vh7Spzs0h
ulPP/+GAi0RPH5RMjSEJswsP+jtseygzMBDkTJhuKH/EJ/E+phaULtXfYVBZwsrt/VaNTFzkgFGh
ZQCZYwUd+/vy3M1z3D5mR2bl/vQBn7/7wu2xsLalnU6GiptpfaweS+/nl761ORZhpwNrkQaZDFwl
D3my/hzVF9qu8Upu3es///zLJ6yZXndDiWWkuuKm82O7NIFumkujKF5Hb29vvDfZkz3niNXKWSbf
KIYsdfmyQg1Bs8AbYS53UbKTgRMNjBx3+3ArnvLXGnRtH4f3kX8CgXrTEbOoLrGvnBnzwPcD4mZC
UzbGQ8b74UO6gLJfbcivSrHYk9rhO0R3a9qLNyZ/KSsGCdlwGKGSuAMAxU4f4pWz5Eb2/nk9/TLr
HKW6Tlv8rKo8B5WTaa9Ddw5feGjNpaYwuj+vnFstwc99+2WYUCtyjn1Gvvf4LB4EX3JE2Hn5CfCj
dvEgiYb6oOzJERyfR9UCxX6un0WHesZPdPvS4dAnTFYoYbeu3p/l0y8PM+lcJEM4AyeLDegs1ldk
8mbmKG5gqNYfyWyPkR079cquuQUeWipPcGPckqHCcJoR2zEuHtBTclSA81XrBF9ns7eRxFjqprcw
FftwZW3fSqGWanfwjJU5bcSXpZv5oiEaIu/B8yY9QGA13urnfktdYSu+iA/cPj5xlnzXvLfb6LW6
w4UMFQDVURSHf+42+b45wktyK4fGz6thPu6uZBNL7Tq57dWuiDscg91zNlPKAfsRAbdLeB4dnmhl
lM9GzrVhFuGK6lClTKBRs8tUQOSitDcnwu0h4Win2nsAp10tIXt+8BUg1zuuthMgmUmH2kj50vT3
nQi3bUAs4S+sptTjYyxWAIi79JeWV1CDhKhr1plCd4g7q0seK3RxYtLecQAzSSmBc+4vmXdy+FTA
HMMIhoJa9ag4gsK8BIrW8ksPLnZB/IAX3zI0E7MeJAAvCS+6ZqgA8QJ6OIyvTfLQCJtA5S8FE9wI
9mgT7eExKG5SIXCT7Cmtj2kUQrcB93u1mb0/UGaGRejPH+pzrVybwkXeV6kRL1DW4lrzLs8OHhb3
K8yN5r7biNTN3/nAnJhdroSiW/tyqcybw4+Xl7kJaS33a2isjBtswDWMET2/DCooxUkdvHafqQaH
mnXtUw4G4/gr4AUgU/LzG9+4VfGL/I/vGk0pAzwCbWZ1IpwJDuixXlcXKwPcuibz86b4EnwGVsLg
Y8SUNk5vjXbqJcgAO6//xdmy/56c51tp5opb7gHwn59f6lZfaMnmhcVR1BQhRVbrjnZ7GLbCNrkP
N5ElbFSnc8EVGbfFWqift9eVNbMkOmVRxiYIoSAVE8cHZQx8KRweoKzosFGx9GQuQCSHOoLJGIHB
9CjZA6yFBen3SGYJSwlaNhTM8dTqmlcZ4NBYRbkc9JWfp+IzKb32dPOt9sv054Vcy3C7RYEOycVe
etE86b4/JsDBWVL+qpY7DQA5M4h2oF1D74veA5IrOHCBmh4DwM2BSGNGvrLg5zGvPcsih6yLLkkh
eodGyfjWkAeqr+3bG4f6klIdk7JMhqBCRj6agbBpgN4Tikuv+K3+qMSlnTf2z9N546rBL0JsnqDA
1g14gxYY6SjiIbrAgVy9hVm1m0UQFfj4eZxbgWjJRpk6Tk2CEosKXY5j+VZv2GN4p9nZG3meLv1r
uvJFPvPovz8JVAO/Lw8gsFtYYmPmZLc9NLvMj8zMItZk6jimVeApcKXoDdXgt9Vj5qG68LR2Xt/Y
pJCT/D50j1ZiLkQYujlJUH0AyBjV1PBVOxfesBHfpTfSGYG8jn+//u3kpUOF0MQDNFUwHqQVjrgi
2pM1eJGToWQ1OpUbWy+aGZqDvdbXuTXeHHK/7Dydwnk8GDGehGKdbjx0Rr1bYyvdaExB4OH7j8uE
owoUgFAbB0phPMAU3Eg8CB8hsfp5BWr4oWsLYxE3orIXQOXCAsyyV4n9Vu5qn/FW1K/UHW4kibK+
iAWxXHYsnEM0HLg2g9cc8029SazEQZVr228hM2SxI/FAbtrI6GJvkzXVgk9ZgGtvtrhSKn3LugQ6
pzt8lWeo7ML9Gwo3kIFWDEHxpsrjBHPuq3ocSOgo9GR2CzmSl5DBDdwet5INWmTdoQU6ZhavmZoV
H6XTz5N+41r/l8OmxpK6ChhmvQbY21FN5EvwrjC4M2hfW/1OtPp97+ZWs6bidyMFgXTm93VUN1VD
aogJ7srLtEtfJauL0VHW9pMb3AOnrfvojamHzo1f8rWE4PodFMqg34cckainwjxkbcOC1Zu/dgyA
DQgP/2FQWzJd6lSExybEZRHOULFjd52fb6QnYEKsdAdmrVd5o9WYyiZ7K3C55l3tYa2Oe2tfknk7
fdn0Wgyz+HrOpxTJ1v8fZ2+2HCnPRQs+ERHMwy1jQs7p9HhD2FU2IEAgZvH0vbKiu6OcX2HO+e+r
EiOkrT2sobpWAXzm4AlSbycSpdt0paL790UKh7PvTxFzHgsWQ1ckn2SH14pTrHoRLH2du8BCZkHu
SIYqCv565DWZnfyiSE5zjJXXkgdQ9CGV2w9ePDtahw7oQ6JeLOmMFN94HMarvIm3tDj0R9ATe8Uh
Z6kLZogSfbWfaYZkyM1iH3j7iKDXsdEm8AAeVk7O0t99F69U6Flzfou2zEOLyE4C4kNax6aBefkf
n3AXsUqi1DWz6K0b9CsuXVWpoQnNoFfnDtwGawwojKd1Tu9C/DXvolTBxiI3qxHfAQRQb3gxjqiB
Ll1I/Tycz+lT/NAdgCas3//vtPH/P5w4TH6/7ymuwZZPF8mtScAiidqapwFt8rnaQPx3mgxb6O+/
rwpw1ea4VcDVx5Z6TjGfrfeii6Bm/175Qgtrdk/gIXGmUhVSQrtBcmscdSg4DaVd6AFFwVmjxWbt
5AeTofaOcDv76qnhOeaLmzV54KXn32U04gD9GyYlGOLA0+ureBgiaLMNazOJ2+H+x711j6eXEpGn
EEUUd/NxOsbvQwh5tuKkP46XJBpHWwqm3Ab5lcyO/vHzgv47rVbvAfaxnkwQVMMTB8izoKWCVDCq
wi5zqtMaSP3fXb7/uCHAi7xIhRpLhnr3o9ima24LS4t1Fw6gOtaUcYPfjSFt1g2tPQiHlMG42v15
aZZu6nsQey1atVXDFHHXZOif0qt5TtD22FnnwYl3UiQE1CuPwjVegzre/vB/ff27eND2iZzx3BJ3
EHtz2+nMFOaOutfphyyF5oA7Yw4ugSx5qK6pdqX9+ef3XNrSd1FBkuch027rCFjQIw7Mnq0WzgvT
ISj7fo8IgqnJ5RRjCZMDfyKn6knBXE/hzvyeH9fq36UE5x4yXjSWRICtBg4oVD0Qw7fGyxTmkVzb
OkPfVSV2umVH3J9mYqPT9POqLaT+99BwqHjMvShi1boQA4vqUQqKTf9hrP38wke5R3LzeIC054j8
xrDQmxLhXA7yzkdvrPz1C8XnfyTHW2FoJz3nt0kkb2ypd4bRgVMEAMj2PF9inxV+L7n9mj3dnVTU
/3/13FuLVdrMWA4Jk50h7KUPbT+CuU7sJEzPcYlRNtqHO2D6VkZnCxFHv4sMvKPGILa4h27lH7BY
m58/+dI3ucsOTHFqG0mIEZ31Fnp5T8JN6PsJGp6WtULhUxZu0HtQdVUOjTXmBq6XqAbQQwPJKYu6
Kz0ZW4BPIu1M3frYAoRV2bUjgu6g+5mbApkFaPeTuW293jbCNeDXwhRUvcdeYzxjjhCJRucQACzq
i5Ec5Ojoxdd62+8wy3C4l/pdlB5garbpN4KL/M9VATnSXn9e8YUQf89FzWIN4ssjKsiGn3SwLTKM
6Dj8MqyVY7BwiO+5pNDBbjMmVGjB2MpOOEBAxRZO8eXnP35BaQAeCd+DH8xTob5d49fn4i3bpd12
igPjbWBPseymaI8D49Kn9to8aqnZco8f54IuNJYwoSQC0QPinGdCaruRQqhWYniXIb3MTVcEicYp
ntK1EedSILkHjAudLubtbdzIxo93pfFH2R90n4WkdmUoC2z65jl+Q3n/85ou4NPhNP19TXW504qa
4nHEDGcr1OQvmToZ9dTcqzRHrGZwlJCZVYmdw16FqZE8b8Q8rFMbzc+miARAB0sYxO8yoIk1SKcL
UlSNqaPMUFg2nFx2GUiMPcPOFnbgZ5HuVVXeS7SYAcln9cvPr7HA21Pv8eSdYMRwmMC3IrsZ2MfJ
squL4UOGyG22oz/Z9RVDUTTo9NP0lbxO79mxhfDOU3v6+fkLHXvYiXxfximZDJJAFmo3+eJT/9Qf
kkg5YFTpal61IxEax790AMroRXSL/zG51eTvz9Rb+JkYt3bQDdCmbavI8PNzvc0wouwc4VXcducu
iL2f33ABVQCbhO9Pkw1mmfWAO0DynwYfJcm+u7KAXLK99jHt4rDapZsqBNwQs58gccjh/4BhtFCo
3kPKLYjiz2qGhARMo400YD+FMw3h9T5DAJd7JYSFGF/pEyxcSvfIcimmsiUVSBpTxZkyb3iIi9fJ
epKff17HpZ+/i2E1g2xu22KjxKOLMRm3oOpxAXeMrw1Oly6Ze9A41JegkNZo+FCu+jiH8iOkmssg
PinPtyQbjTAg1DnQ4+CM4VxE5PaxgjeKCmjNg3oh777HkQuazgbSVeoOQusDpL+TfdUOKzf6AhwD
Mrvf92EZawRRDK8HezOb1CG9irKP0k4NFcvtLH8wH2N20tnTSN0ZrLDaYxe48lH2XLEnc4ZWSfli
knAyoj5mGE1qDgY2dI4GtG1QFGo7SEFnajgFo2UnwkbGDNEot3XjpyDesWFlly1clPf480qnGco4
pIvzsUsele7CoU2S+Qr0UdbMcJZqhXucuV4LoyJlmbQTn9KrsunQy5tQ3dvFHumN8/N2XqoV7l1G
IBrdG23foVbojXOvqL+k9FHGuF7blJYz8S/Vyp18TD3MZV7brLz0GsSnhFMrg56rVcfaWssO/lzL
/6j27jHmPTW1tLt1MMV8q3FQqUR/qK6svzB+1GMZUveTYzyrRxkMr4xAhCxo+OxXB70OFAAYUshg
za1Li5tQTYeTCQipuCHHUv2sSeFDqo8Q/CYA05NvmV5ZiXYK0Jrw3Fs2UYMMot5951p4rcJJVE+X
P0VwMSV4G6nFnhho/42ZragRPOsaNrl94oLt4Mkga5rdTlTffv4eC+2HP6fmr15q0c6WVteYHItO
86BHn0NEoyEgwc+/vnCw7wHrXOUQ24obxGHtl9i9xsnKoV5IS++VV6EkmLAywaebyyPmCVW6sSpu
J6sSVQv3xz0GfNaJrFG013YjCbXYLR+HSIkkD4XHhPz057VZStzu4d39VEBUeUCvc/Ch3WHndh1K
mzIkfuyj6WidipUjt1CM3YO69UrtpUbNsVgKSCrFq9HA3qMPf36LpeHmH6TQXxvIqpJWxC7CBkIV
e5SgGgmVOqRR5QbOLt68xRTAw45vNvQJuOWoe2qC/LqKuloIi/eQbtlsulStUnRw7aJ0kMWpT3Rr
7jLw0W/zFcvJgtlLPcCKrVdjpSZaakvdA7SrnKSIHdjVRTj4cdAGw45cs23pma4WmD4kZcxffGf8
r/vkLpHiXERziOKIjtF0NKN8D0iRehIuhS054rN14ivl0tJhvR2Gv75k2lQDKU1serVIbAWQKaJd
f94kS0H/HnY9dW2nmAmCvtT3+1xp0RBOgX+Jj4YCNTFt8pTWcKr4cRJ1j82YhMeKqwlglpQtKu1u
V6uKpw5fK3/NLcf+R+C/d5GPobmqzQRlYeeOXnvp9+X+s8Niyq65GfbpSrq9sDXvcdl5yuqqlfHZ
GinfifLgtFPlDWyGh1DuNmoZ0nZaOYRLhe6f1O6vTzeqonxDGdwY9WoEkkoE3I+9E4IKFC1t5SEL
KBf4/XzfH3IlS5ZxQ9jRUPba4PaQxMv38qvqAnEYgC3UbEEHD5KHIiCPxkkIU5igoKSwVv6CpcHf
PSAbCCDgNW6vCegJeGnMyYCbABvVWYvJ1sLOuKvKuElgEC+hSZY3PoOxurhpc7f1JdB8uqhPV27F
pV7cPeC6maGYa0xYSWHT2vGfTwZOTQQ6GzQ0uJsf13BTS+9zFzpg4VNYcFPFTm89wE9qCIPBYuTU
nNfQRgvVyT2+WovjMskNPECPYJnkzOdpvwYMX/jpP5XzX3u6G/JeIxV+WjEeYXk1xL6Sg1F+rNPz
z3Fg4YDeg5+ZYvSGMOEBXAr6SwxtEAtdCgYGm6OvOX4v1fl/IuJfbzHNlAior7D4pQdhvb56TwvH
RKs3gmVNzg8SCowWsjmJnVDoJ7Av2XKhhpxZkDfyf37PpV7Hn3vsr78Btu7KPEr4G3IMlFWnK48G
bDunjQG9O7iNiU+mWwlPVTa6ZAr67sXkGx2KAuXe9AegBlD71HthBxGl3z//QUvh6k8D7a8/iMdZ
UtYw4tnND4MrbKuD7GXnQAo0zQafYqUBsbj0t3vur6c0qS5k4oiSqePPWhU2fCvCk6qDnuCsvzGT
22q/yeBjBec3gjFsKkeVueHC1piu4jsd7Sxfw0ou0BDg0fD9TxGoYSSyhR6BNsqnPmn87DWj8Lgz
9M2g+XBB2hNlnylnTmwdSQV5gkpdKYVih1JiX4pgYG5jmq7kg0sH664N1NdVasUMf4zA4QXfge4k
Q+bcAK8TUpzpCvZoIUP/U2P+tfioVsvBgFvBrjY284ypnXZhKXo9K1fBQk7754b46+f7OYfcd413
oD3YSBKDkxyomtraIHAhQ7gHDVM2CJ11u2hAfA7q3WwPW+UwOGA5e0DroP3x80FYCM/3wGABLihd
aeIxgw9PcgdDVNATxN3aXG4pN7+HBaOfCvvFW3EnQ1jqlDxwpzjmke4aL+X78Cy/GFCOhExRspec
wnJADc7dBAorazOuhT1wjxDOpLqg/XB7PaBb8imELLuVwtuLrEyZFgL4f0DBBGZmaXZ7PTDy2QHp
gGNigr5yTJaSVvEufrRzIuidgDTfzBEc7PGJ+uYDRNE9c7R7d446x7hytDC1c7H5eT8sMH5V8S5O
9HM6V9WtXpbhg4fAsJE2lWAXYJ8Se8KoSd40xNUTNEzzk3ALlnzlyUtQwXt0r0w7MatkPHn6Bb5d
0biwH9Qx9PaSQD0WvuCQJ6hi4E2tfX7NIdeE1MtbS1MWmDwwHPseH60ssXgO5QpM3ZK3Cl9z9lUn
RoB8SDaxy1/zgO/7PTCyLsg79CKc58aGCvaebHW/2vQOgIvp58o3uD3zH9XBPSo4SS01lRVErtGh
LvWH7XxufcWpgzZaE31Z+M7KPSK4kdTcTDVAEMuD9UIHrKYz7HAUn2KXOZBL3sW+5qk+SMYaQFwr
x+XfMfM/nu8ynVuRTLOyMzP5S+iAPYTTKrhn9NfPK/fv4w6rse8fkaPjn1Y6Fs46piBjtrs1xOZC
AgPbiu+/nI/QMyUqCja6k9/RBMfJeO5+KT76ZfVuOLF99ogt6sHd9FTt5GZTZE4Raa/yjq8s3ULG
Apvw73+BwaAS/AfX3EDj4B1qwbCtAPugFWy4yjjTp2mnyVpDfqG/AOfu7w/j7cxSeJgibgILbJPB
qUEe+C2ejNaeoxl9rl9Qym6fx2iM9NW+7O3H/7vt4Vrz/aGTIYgxv23J7qV8YqBxIB39pbuKG4ed
J25zf5VW++/mmmLd5R9DrUgzmwDc6C8CRFJsI5hws9I9Q5hbqb2XXuYunvQmH6Q56zBSNst+Y8rj
7LQ5a1au7YU6FEKT39fKZHBKIxL2Y/IOjSjBGxzIMSfOo7QGPlkIx8o9fhduLzzteybujIfkgiky
uY5f6hMQSbApyDJQr8EllE48ovvRLQqbu3S/6plz+w7/2An3yN5cJf8vrGtGERA1/mwcy8DyKIQI
ct8gXuOylWO1EDHugbytNJFiVnvgrdAMn0X4vOkHs5dsga6JKfw7w1LuQbwGMZqEyzcEQOxDtLsR
XJ5Cp7UEIkmgTgN5Q7JSTS5tCvMuRHCYCc2dgfBnjA9T5sbNe2+ojgEB/D55FV6E6SVb0+j8d+Kj
3EtBq7GlFWoCHC7NXAVM0zrsyt+95U+GP8Hp+X8K5+ZdQFBLCYaEMVN2sZRK7zqpSwfe19ACasa0
t2sYy9k/P2gp3t3DcIdUjhOp7udd6pARsOKcwOHkpYjdHpDI0oWEtatAkLJidkVDdXaH4ZU2qaus
nbal6/gelmuYZlsYZJh3QxyN1bbnInye7Zp6IoiCEK+NG1AkAxZlU1jGIf+FsN8nn2Wxq0txZfv8
mTr969TdxZS4M0oLuvyQXW2u4AnaUk3ccX4VDS9VdmTy5hgKbOZ86OtD3r1xOKbnmepI1QucH2NW
OUPBHseJws0VzE1GnZobF1JsFCgMW1PiNT3zSoU5ZbxBpwMipAVKskCHaK5UbuW69kryPmISRWVI
BIqenF1b4zfv/f/tE9+jhjNRydiUY4WFbRzJX/QKdEVkONwvDs1GOldXmtsP5HHlaQun/l6OO7NG
KsEDGkrwTrIRIeo5epj7+slNPAvqdek7er2QqoY6s71yWBZUg/7jc1hJsSnBgApyv2B/y9e2RSeJ
0qOcQKaweGx1UE2Sk6pBWGu+UqIFqQ52Os29IqM73ZiPjF0hSwKjAhwBCOvqOkyGgVZI7ZJMDrTy
e+7WagWzYgpHhAnmz7C9PfBOXzmDfwBX/9h+9zBk08i72VBGeADBkXEEEBmB2Z+1TU4MdCKuJhg8
bYtziRZNL/NATn/nwqGumt8QubaT4tecv/eVFPDk0yyeqYSGVjjC77xRNx15Fsixh8o1tI+tBxgY
5+jqZ1Cy0Mi4LXHKdWhUtwCAxYXLpGcdgxxRo0e1CupasAXxrKSfUDlx4DDuyqlgl/Rlaor9IASF
5bUwyuD4OSjiWArdG5bpGI2ng8I7Visj0oVBnWLcRXYhM1jeaRD1FdELkFzhIm2oi4btEwtT4O6E
laHmQlQ3bsnMXz0NonO9Z5rKdyYA9SoEle0ENhhJBWo2v1rD68+HYwHABcvC74/JsKGKUYO+8+CO
e/imWH7+1QTAoGobOcDd29qYD86S6fQB2RkvcECGo5Vm2LJTjbUt73I0L/2LcLM+ajdD6vQtmpnQ
0RgOHRRDzJUNuXQpGLfs5K/V6CVJhccBDhQCck4/ICm+VY+zJ96kiPIXA77zIMKDK+NIxF0rNBZo
a8q9prgW652YTERESxguumN7VmcMF0BZ1I/Zc226SX2cpetY/+pbXzyz2IH3+mS+qNJkt131LINi
CQbbL5ibugqmVmLmD+Oecyct3BJNP21PUn2lYl8qSe6R3UQGH1pQkCJKbcSS2bcI1gTqhJBZkLw2
ebXA2gfgu3kV2VpLZGGH3uO857qrpxwm6jvo8V0KPwn1TXtaK0+Xqrx7QDfhtM3pjaYAp1wSoPqW
D1qNFQ6HD/WKNjnE3KEgueVb7Wqd6ddwaQpnPkmQ0A6q7dqUa6Fr/B+TbK4rVlW0t8N+1iPyCq+h
gOylUHLzaNgWx3KPzocA7bfyt4o/5eczCSPuhVRYvytxW1MFrKOTIaZfkqsqWmeRv9RC/kGH/lwp
emcAFZJKtpQDVTRDowA2sIp0ybQkarIWDr90X7HElREF6ZnHJzPzq+Y8VA9Eg1Ughf88xg6wTrQV
uD4l03SKa+jkl/x3CtPvLuGHRis3ZoXpPKnh/kMgvCxDSDpvkQA1KDat2CkZbCizZjvHHbowo5cU
iTdC4bNIPSUG1VfsLoJkcfjV65AfqXxLllw2qS508G1TDmm5K3q2H60HBrKnIobAtHkdNVNQ945S
7HWT6QjyO648t4tHvzer9z4LRW1wJLyuZr4SAnvjm3eCaMf9R1nBzaQoXrlVO9T4SlprY06tk88y
c3Hd5J1fT89i6QsdeuqV2RCnSCCLkA+ZLfNTqhalrUj1ISlTiGnyETinbKz9ucu9rp8iJEtmE8Iu
K4Kb+VucFFv4dj4PpHCtnD5q6RTUqvqaWoUzteVHOo3HbkpDyQr6GrqnHRU3XWfZIDzILdnVWQMh
JRWnkMuEQkFJzWhvt5WGwKXoHp3hSwCJK/k1z4NSjkjyu2p7V4UCELzH7ZSYiL7UNgZQddUBjJS+
FrszG/W31lQOVmORoDF6vfSMUie/hlJmHzA/LiHLwuB0QK0JKwg1LZg6CRN1ExhIhkICZ4qStYaN
VeT20Bj4l4Ose1wdbE1B8ALR36MWJK6F5iXVm+RFq+gzKd+6oht2Wq4F0qS51ZCbm0Llb1LLi02l
aO1LmkKT2lLp11yxYB5b6Et6pHuI0+PYPzb6MU1bR4AlRO1zKFGwYQNNfGT0Bk1PaePkseUpSZBL
DokjTktYHZSwWDStHhOasElh2HrOGQfV7Hd8s9Q+KaATp1uShCXZdHU0NccWqXCax47S124MuafJ
hmZeOtpi50KbFls3RRzW3VIIJuhUd9lO7Xcid3r1DGHxQt2gEIUAnClchmmXtoC06IHWOGhgGx6c
fBUnzp/EeQ+viHIESrIR3UayYTG/LUS2jyEaUmKOAim0kzmnFwuGjRyElKo+jPlDjX1rvHARFmMM
/pYPmtnvquazZJ8TzpzawBxDfq8nbBJluLRdGpi5+oxxHRhiBkoSYXIzlQDuJ6aQ+ewdVOlOijMu
1Veqnub4CpftKjSoeITYyLFopH0jNx6Dy1fIu+S5l0w/0dFPnC+5dChBbJvGtzmvtngNPmI2KUC4
p32K2ewMVrflYgL8tRWNSmyFHZUfFK5e4GmrXM14bDclrHCF1BWUqdhqBE0JHN66pDAeohCywtZQ
McBqoPVE7LoSHbV4VljqTpxcIVI6cnzzFNa0zPArdhjmmTmmIYaG4pVD6U05DEMav5zm54GBoA6r
t8ESkIvaU3LoXwuuY1HL4zDCQ1eAnlQ6oFWeAV4OixMhwSCr8wRsFa3IfJRnII3CEGa8ThLxG2N2
K01xKqPFRxJZKDGXyp5443pB9aXaUYEm0C/dC4Y7oKsiQjLag/uRe/sdFa6Q045qULuXrYBkmuUz
sa02SgpEu6XXr6xWT7XM412ZPIzjsWefHWlsOA93PMjZ1cRX1zN0izoXvAOcjlKvHKMXnVbZ6sIm
M2ns0v4wQ8LVzNhOSIuwRLM/gYW702TWNYa5sDvgNlQE/UHuWlh/CXmEBR4DVuzRebISDzKUzc5A
ZDuKaF0bp6GDhimYS2lxFgdbKN6AzDetBziHiMOHbsWaLQCu8VZYgcg3cNAA25joTlc40gf+J5tD
0jk1jDVMWxodCVBGDAQUe4Aiv54dRvjwVDtxtpPyUkmnDJpX1OtQwCTMN6VtF5+F+SstQdGjv6QS
8h3wvjAgVpv3yePQpBuBFKGeFo8dYRCkzSs5aMsoxaCDtWVgDqnhK2DhaRYcgCc9aHFf9YoMsfvc
aftmcnIo8EKiVMOVpiEK3qQct4lyRSTPOGyBOCSL3jSMEhJta6G+UukICQqjdjRtk4pz59CqxhOS
rtszamQf0kOT+ZPmxQW4froj38azwFuWAUq9AGQwCGhPhiPpmY3N4yWt6ggVECgZeEjJadRkdzY6
WzBhpWjsWxjtmAmC6ByWX8UMbRfQPi41PBlyGKGFnZ47XQWPOkLHV7Xtj1MHlzc4K6D1wT1a7GAl
l8uQK4OT3eD1UlQrnpB6TMHMGKo2HZ5rWk46Zh0oFli19yw/tJCjzVEWjeBg7ukcKjlqSfVTEaE0
oLq8OhDxsZwFu0InoIsM3ZNajFiaR0hHBVq7S1Q3ScELZP1Zqw714LWQ7FLRCIAxagl7p+5hPg8A
+JDuAiomjRs451EP5iKm4fUZ3AXUR84Rj+jk66Cet3LvdHyCYbXbi28m+W3AoaJDGeNnn72JIAEm
bYU4BcALQLMwtpPCylIcWfYlybOaa5M8alWk3EKFrQ/7im4xjUrKg869BmLb6FCrdmU4dY049ypM
D+V8rVC0qL07xKEMTlsf0G5jwfkTPb6XOdli/qjicMzpO1ykfFO2dpbO9sjy4Ns7opNvSJ3XsxJx
iPBLzbUwwRetE/Googot6qzbEdj20KbBOArjOUdls2fNU0QgPuIlYosrhudH3UTfSEo9ouvv5lva
eBmdsWmJo+jyJmmLLaSoouG2+OjommPu93AIZTNc8Sp/QKCv8S3QuemmKYJuhyOx3qX8UGBKPzDj
1HSO1UVF2rnyxALeD9RhDdtp6APocNJWFXZk3U4WHmKl2LbyO6yVKY/Bzu+Gk5IJJ1BOHAaBUKhM
XnsDPSUh0gXYnzJITE6jZKuTQ0yyHyemIDxRHR6dVbPtZaNyrJkjs5I2cvLSG2gZ9aqBpEpskewh
KUtlw+flVH7MAy58YiguKX2AlyGGbFWBmug+h5m40rVuPyt2j+4/mpbi3qhxfvMQl4ChgkRezZHK
TV+mKCtlPUjZeJzGF8yLbaa2jgjtwKYcXRkejLxSnVTbWYUGXDblW2tmsCeGpAgutkx/qMfWB7ES
/pFwk0UvwBJK2CeL6QuNjUCI30W0DNBts2crsowzXE4DK5FhfHrbzCACxVS1zXPTBFoZR7VlfnEl
UdyBCKeShnEtvksEPkwZPrU2sECuR6wYOvOPHcZOc2A+AEiuaaZtGVsAvhmykLl543wKrAYyT8NT
ab3J4lM3P6kcaZ1XF+cZ1olS53MYd0DfPQ5TaFYiFXBknVxGWfkcwO9yRBihQPetByqtPLKs3leD
JdsKFUK9xo4Vmo0x+HIViCX5pRrMS60OErq3sWI1wzwe5qwN1b2x0IkN9vwEv6Rky2g57ka9hSke
7dIw5VM0QHDbBpn3MlTSXu94ulHE4bXCHb4B99IKquZdmolHifU5TfBYrYgz6E9ER/oOyD767NkJ
1u4w5ZTKj5ygMBlKmN+NUHwZmNsWgG/xPkI2G7JY2FKJbNI6DmAz+gT5vq2qCgEfkeIMNPtSLEgq
J/Ca02Bqb5hvIjeQpGHb6fAnR7QESqKiB1zOWwXo4rbZzeQts15FDaHiYORWauc48HSAqScsCnKv
RpOp1VpPYAglwwSZHYy7t+08wd4ZVCw7s/p0N3XmpomVY200Ow1Dt6Qut/NkgcKGYqCJ/SIhbiVR
LF8tbtSuwqB85rspKf1szhyNP4uq/lZPKNMkui0lHCh0XIn2SdrXFBlSV9ZwjAcTwGOa5s19e5Sz
zhEVP5U/Wsx6TYU+CNKlhnhKMz7CE3VXqsVp6hIwDUz8Egx/Dj2eILccau8FR9KmPLdN9coVa1O1
+RNNxycZ/ZlJPrF+N9H0E74X8L6E8xk8sgYe417E/KYUQKaz4/qawBlTwg586OAlgrOQe3l9QISt
Kk9utzmG0JLPraAsHiyUA8g1bmdXraPOkjcShXcZbn82YpfAQfxq9CxkGcIu01wuABkqvY/iVedu
T8AcUqVPuehftPE3NqGLegzxw4nL0mtS4sb55Mbsl27Ablz5rAZvNtiOI5Frx2wnKaItdJ+6KdgS
XKnpo2Key8wtDSiSo9VdQYZiQi9Voa+KRk5WLMGbSMhDDjoJ0zliHEaoY+XK+sucFhE3q0eWAT3Q
lhtZdEoRgtYg0RSaa1iRgTxR+UUSF7G1y99UA4vkZKBhEKxcv6kzT82uMdi19CVVXBMCHqKwM8VN
+YEBY6M5CSTD6euovGhmiCxhnoK8RSdDirIRPqhtGhmWrzHc1ChTttrUn+bR3CcQzADfSGypK2Dc
23VIaSGYOujOADWrLodmKnKi7vc0w9sJLl3KS8wDArOGBnTxrEw8mRxU9q6DvmQOBMaIKO0GX9T3
OTq3EMGE31iX+8yI9OqA6NnghhnITgFXUzzLEJaccH7qzjVFmLbCq1A1Xct8SyCp08AZWw41zCDj
d/6YApjAbvrDpewb89MESl9bOB2aTnAZkcIaB4odYsXX4r1pwaDIQaVTI+PrBLc3Dp1SIhZtiw5q
t7N1MJEFqznzJOhBoSHcN7kr5T2cixCykWW3ZRImqLgUK/cSVAtyjmMtYqZ24RRN386tebKH0F3Q
dqgopi4SutS3JGhmZrdGQgaTKOYl3WcMV9Gs4D4bKsS4ys6aYEiCRiugBPnYqNDYCUrJM4oYL9Fs
SZG4FVGQG2euLk7HsTJCLcG8XVV+iwnEqMpmg6v9JIyqLxR+DIXF6SUGf6OhRchFT9GjqvwyEHom
irLDk9AujUkoA1lpm6BtY5IT9uzNUMMB4PqKv7f1SQXrg9qYL3Vw+kEEKGxk3/ngFdymn3B6sFml
P5VtKKeHTniBu3cgjPAtMyESADE5rL7ZufBxNa29VCAzircWrtqhAkmN1BX6ZJWW/b5JQ6JaNoz+
nFbj+KoxcXpVY9aiVWn2aiQIla+MU0Bo56E/wZw0zX0d7tBxh8pXBuWbVF8mzlpCGwiyj2pUNFM0
JlkgW7CO0OfTLMlgTOV+x4eQSs3vWdezPVLgqyUmdAOoiQPFpmun1BdWjl9JgsINM0w7jlMj6FJ6
qU3wp2LTuojc0u1JT1G98BgutsK5krnTwo4a7+WKvP/4f0g6j+XGkSyKfhEiYBJuSzga0YiURKk2
CFl47/H1c9iz6omeqq4SCWS+d62Vj3EQhcqfZCleNYQ/y3TNmtPaOfU/rfmGIxywfrDzDK6WO/m3
QcBYOrbeMjwGOLM/VHdJpQeHNDoi6qzgQbZYbGTiWCcY/DxToi3LVabNUnrK7PfVZ5Xwt98I5UV0
m7x2YvGwJ+x4Y0XlJfneUny9i5yw9SlHA2JYinfyKRkESyS/bi8fFBC7uqEMfkffgG1figq79J/x
pZzFm/YhLT7l3kqgDK5iuHXn58ltSI+D3jkwx/ql57LWIxewAicrudhxHGTVqeXf5vx4M2jbpsuP
Q7orid4cnTINGhIv7bOWBgbl2YiKS9NrqGRmC472EoNO9WoQKhVex0b1hmIzZt+J4YeozpWdOGoo
EauVtMUvM802eQjl+dbgWuu2qXYoinqXGgEl8Fhdp/4rHlw12YXprxR/hutL1H+P2bqrFb8ljap2
Wf1KYMKoJSR4QyNt13h2fa7MleMUOVsEBpbtGeTWuvJT69Me01Oukyls8Mt4PXSKDmr6ckXpzCmP
RrbLblodsYFem9TjLllSVy2JwErjI2rioOniJ2E9GWe9fsJFbhGkg2ymdu1vaWzYsr3IfCtAJspz
N+6UlUb4DKqe2LDGYA8/tOmeMUHCti/Tc4Cp0n4t7F2tv8cKBsR8uhri2ySgNwVgoqR+4jAr30VL
t6NkeKJ5Kko3ln86lbjf8stGP1f81eNFh/3X8JZXHkGfig7AcVSLD3CmPj6H9a7Rb2V2bPWnCvc8
EvAC9zziJlnyuPSWdqeoOwaCtfopQy+ntzwvXBPQrveIQ92oYFXp3D9siCTCx6Phxn9cSSFVg7N4
LTvBMesPEkALHcTDkXGkxmX2zYznNvVWIZLtXlQb64tLpXurfvXGj5qX3NgJPPn03FOr0+PsINK4
1+zxHBbVMw2mG63mw6SoXr7aYUCBZWy98rOY1XN5E/FbNJ/JGpbW11ZjsokTJ03KU92zx7NUG3GB
lGkIDJkfbj2G91JasUzTmKTvBFlxWQ1yc8jtPDDLlDeeiEDbVeKLtBdkSJckhz8VTfVmcEvmDGFq
zDKbv+nVJVo2VfEc9jzyR4N1phR8A0gCZUH8M72bixNZlyW72evK2HeEWR/bM3K1jWk+LdWl1F6b
8KQz0FawYLmvhe6obov8kOCzHjTAw8wHt0rLXXetOAcJZ+5UHln2mltd+qbxb1j3hQTGGzT/umw7
Yfw1PzUqcmQuTWyD8z9+LjMOJpl6duW7FFvAzU1e7fXEJ4SFChLb9Idf3jLJ9nqxhQGdmEDWS2K+
1uXvkH8aTfcM3o4KQeue6t4RGd/dO3/XMv2YtXbTtFCG5hWxqM3X19nyNgaLqKvnufhYktNKQkj0
3pXRptCe0zAo2cejjWm/itkFdrNPaQsOpgVauUOd5ZicVCOLGCBQTv+JeVeag4HsKIsPI6Ms54jh
tB3P+1PKvT8YrPMKZ8oquUBDjBRtuWMCYllOeB8pH+JZCGcc1RuS2UG9bIxsth9y10Wfovqe8veu
dQSeIkJo7HNZlQ4RvQZYiXLoKnAU44yIYSwpNQrM9MLuVKpcm0a+MbU3i7EidKrVkVHEds8NWZIF
l8dfpl+06lLkjhEFkfaj27mrGy9Z5OTpLm6DQWwhObiGR9OZqHOoX8kNTnNiy6TjUt46urTr05Be
4u6ulwC4h06avBHPQJr/m+2dJv8x0TVS5BhMKSpzTHzIVixsmSvNaHCcpqEVY1PyzDO9yMwjm7i1
dlMobn0VwZ/w8xHUQi2rvul+pmrLm1LHbtoGVrptW4aXl66RNl30GxoHI9yviGBj18yD8adJGdVI
cMKmr3vx20wP7+yq3RnfMLNgx4Knvtgg7k8aNcgWKwrgksy7nHAFBgYoiZTumih38/YtM2hDLyA8
DunA0GjupO5ztUzHSPYFeYdd5cjmtkTiTNOGynUamKds9oT6tv5qyV2lUl1i+b2H2OQ5l43SkQu+
ffqj3Kh0TU6s4oiURNJ/OuDWl0VYYNub4lFmwzmaU4zb+xKGSVqcYATmn1l4/YE08kVBAgS8+MIN
ZIYk2Klb1fjO5vf2UnGxxNuE3BbGtPDXyO8TSmCgrJyjVjhaH7podEaD8RzYEfxjM3W7BbWkbn5E
2rETJOZk/hTzIc2v6nTgScgbMEJHw47XuHZ3knuknYC9riruCeCDeRlnl/QnjT1SeZPguwVIstQY
7jgDiSHGMDdm81uFp4lYaXsnPgzwnJixebtY54perWFjWOQOvE1S5aJ73KzLzwMP/ED2a8pP8vw8
Iyli9a+rYOm8OvXlyakkN+y8rt8RWy0n/6xxl6WlO08wYfLwrI3hZjWtIIrIme+ey5k3jPVTp9kA
ld45ra/R6LX1tpn27WtDCSgJ83/sniFSSHGPUCtaXngbEJR/mH9D5saKU8kk1G9Ve4PLx5q2476H
Pxg8lTv6V0v3ym8hSO4nTDAKhTdE/6z+fVaexYtGDIE6Pnfv2hJU/I00b11WoMprGSlbZhAayxy2
+DD5t2qyoyHZIjxBL80dVzK4DNsCn0OQPSA7jt5zpH8qCSel1xcHwHpb/Y0jN+++kjwAaaUh25pf
FenQtW42b0M5YOEz/kRmOu1HKn7q4ROQl8roTfpPZaS+ZaXFQ1Y/NA1aFRQg7/kpnJtdaxzhsTf5
8iS4daUBFNavNfDBmYrZz4EEAOtZ/quqK6tEbmxFVG2a+aBXXNMze+vOzL4b5UfTrw/8nyAoTja1
uPwHLD0eObFJn5J4S3SM7ejVFn4AFZcMMBSvX0a6k2lill9zvvKJ37xikM5u4M0buFYzvMk3eJOO
bmZjDpr5Vc9vKc9UXBMmTlTtdBW7vj7VWmAubjj7oCUIwigDIIS7QN3ILsPbRb5R0Mq7RvF53sz5
38C1ED31umeGzhAFYV26VMJW022NiTw42M0NqHj6HqLGqd6FuPG1y52bk1RuBGPrA1VPWB6+VuOQ
htQaUDFMWGHDUCM1fGvLmw49k7x10u/aOioPjrnAexweRQTioWNz7KhwtNqzlcodih/SHszISy9r
e9cE+IrCTUj0/jtZcVK2ZYquF29ELyVx/QetQAJAd3P7RX2trR9yPUizba44NrMrFTkW6WJ9YFmc
0X7O6sspRG26VGyzIeDVNAofhFuinw84Kfdl+y3+XHo29QJuSnXGeKubJwWZn3rsm62tfk/8y3U3
mrs625TSPaxf689SDfdh+gpz8lh67AGRfkvMV/feHQWQfjtrjpY/t8ZBGbnMFWzLr3Z4n2NEIZXD
l8CspjBor7qbQolxEndMzgYM+biRx0cAUuJmFdpu/mmvTFT1i5iLw2ywtAl/4tnKsKFupBcDs0Px
KzTlo1Lw3uZgeTNEBu6qVtW4OQ5L6fZGfTT/f73T2FDRALVMkxPT0lRVn4L+A5wrxrPZqO8SAMRG
0ocHh10VTtfC2nMNWSDPepGBEtFWE3UvrdbsuyXeqWXlGEO9bevwT07rf/ZofUlqEjRQy5vMSBzR
bY0s84tJeKblqcbIxbIpI1+wzV4QMiEg3ViKW8U/avylokZQD6EVsIJTNthqO6U+PGC42JWNPyj7
4ocW+m2iEbqNZ686N7ehibxh+RtGzUWB0nFxgTlvBf9lWfOUVRuCuW9ih/g2f9S9VvFXyy+hWvQh
+ZuNvQp1MlvDRyk8lvGmc4Q1HbOGDOZ+PCw9L3EBJqZirwGkVpNTdbW7j0iX/XQi1q3J/MjMnoEA
/Gx41Hep13F8LPYAtTMVuXX7mJNl4v25guZ29qKG47Vej2Bq4Tp+KNYt0dLnKtyl/Gpdl65CupEt
2mZcEwTdX+L4yL05Lf5qM2M96X/R9DuhtI5AADYM+ERQmK4iDhPSRY20rIhELYej9jH0wgz3D/Rh
AfjuL1O0Lcf9AhILWQWVoEXPdgl/Ac+z05XDagC5q16dcQqu+2oBJtqtK2zckVs4GRzL8MV8K8nb
bjeh4VUYNENaTIJR7nbVcqp+TDRXmTleAJdBKcbxIg176br2T9RZ4KEczQ/divh03VwNCnNr1xHa
hl+DqJTqrN5mbVdkZPftKLnbZNQ2cuqNg8/CLdoXYV9RuxAnjZxAUm8qjz5zMt/RJNw5OqRMGTID
AnktFlFqEEYRQVJ08I38QsDr7is3P4Zpa6q7haQi6rrmnxFNYAGBdx45y8XAtFZ4GTRxOJM3rsXb
bjwX6ZttHJfplMGyAvTqe9GjtwPcbR4lgHPj50MC2v9ONA7syY0hjxFFIZ/xdVzOjXLr/+yfPDE2
Q+IZ4Xc9A2AlyW02hg+Fm2HhNw/xvao/c5Rg9nQYafITzpT4kKJa70rYu/rRsZ6aUWGU+MiYHhkj
cx/8Tps39tamqSo851mQlzd7fGpHT8rPMtzykB1oYLc06768N6CevzK7NrhnUP9U4a9uOZnN0o9W
OZMdPndZP62zq/N5zw7JuYazCAZXp3xLJtqSlMKLk4+6OcpfFr9myLy5+Amrt4FEV5FdWAEhIWGP
hDiuVer2gvsTx2Cn7KOqO4gWDpBEIijGQt6tI5sEyDFQn8+73DM7HY38LVuh05GzDIgD8s4XfLz5
neibWSyHhjlONVy7f1qVc94480Toc0DQhi8OofmoOBXe0nzMMjy/I7Tf5SGnQFFje2wfGrKVhmHj
sd9kKoMFKpLcqUD8GBlQ+tgYfdOP7kVhNamdXtvOq6dd7cvYvjX31HZ4HgBBASuUCHJL+svLf6SS
1YVvf5QMmsp7C8wSpVu5tN2l3EQoZAtXMzd1LLvqJSmhw93H7PaxLH4YbnECydZXQ9/qGfQcizVM
0dnmOqgUPvQpEP2+HthobLo/1EMzfGHJfTLJ/BarL0Fjrl/hiFqifJk+pEcSTP8kodJoa1psez/h
0JB3M6tStRL0d4w0VLGPewZWQa29cDiu0SlbPprkPYo9W/4nQ9El4m5kdqA/zbI3G3CPhxwE3ob+
obhDToxXW5G/hkI6RA03TUjQ45sFti/V70bKMevGNLoTgj5+EpkfZy67RonK0HpadCKuDL4chPri
dw73RSoFMvx1HO7kiQ8ovQ1j49tFFjQmHA7E3Xqu0dJFEKAIscenOuSciFyDV7uuvtP4lIBMR5HT
IiKJ2q3VFs5COxsLQ9x+6dKLVkyIgyY0+dg9eUMik+Ed6WMZ++laMkOAaxvcUo3hmdnkLTp6nDwC
eNCyc59Pm1oxjwOMPvnOkqOpz0N0o2ISrjuyEUhtmLdHs2W9z65xTSLAmOstGigQE7XeZgblNhZb
eJH7MbsizDOISX+36k9LCXguWcaBFKXp2Fafuc0zkQC4MJ1acXVSLNUprWepcx8f9fgs+nPBHxjl
n/zXzBQZo/Wci5+wJi37nsrI8xUWcPVFomY31v157Yk5YtllTg5RhXNUFFvlTwW0t2MfZKRZVuSQ
oSrc0rhLNR/KoeYoXD8r+6uLosdvOfD8p6hijIg14ShM5u7EUcV1mmOUX8UHV7alACeaxmZEol2Y
2b/OAELNZzJt7uAg2HQQkEEMvMvdUxn/dfDwC9vu+LeKzv1PqHJe9dMAtR6xozWcibJlvVeMREn7
PubZXrPQZMXpXuUvHlnmgVrMQzErt4FMgmlfipcwuwi0jFH4JndT5662ch76MfRa9TFtVh9xngbF
QZo/bAX8GqGbM/CjDG+JfVXV0Z/zfbfCU4XPZQSipD330b5SYQ6virTVLW+1Q9cYf9vKi2FXDHNH
uSvTrl7uEuk1UUcm7W+j+hJATEm/0wV0yyZtaZwsQd4zEmGLaz/1p7RQr7kAq6a+LC72OjGKxbdo
kUv0iwzrXMB0rp9Tx0Ua2zdirHnn5vbLmJNXyYZrr1fdL5UR/gnlo9ZWu2bgDe8HnXPN/B56kBJu
YGWSrO2QWZ9hvOzp6XuJhv2svprIiissBElz16XouQPUblkwElMajwnsPnCaJTtlArGbMbT4uibH
fq3qV9OIkpsmEAg1ETN9uVY7YUe3yqS8RyAcrb7VKPNUXdtJDWrGYr2v8gMC4siJZBvd/ymPYXIR
QonwoQxkbxR2ey9sqvQka9yLacQLQK7aRpTqdrDj0GlSM3MGuRmDuBdfUWtGPkwoqoUlPlohAhKh
jXSHKkz35TmU/D7fCsXG3+biO5i06U3ifg/1yzK+sH626cG28E40iVuiSCq/dEO4JkUI60ZvWacy
wvQtnDBOG/0l0lWjpIglFKuMrU3PVDRBwikIGzIFj9nca9QENtU1t6RDo0iTY0map5PLofKi2q7V
3wY9cZVyu2ifugX/pQZ5z9OgfrYzK36BmqIu4UrgLK0HQUcKcaU5JkFGa92c2ri+G4ZC5fYIE6V6
iNnFPlX080jwJjDBwhRrAWFReswYvE0MuALtQ8RkVMbxuGu74mmcBgGrFcJ2ETAcW0HTyHyZGOYc
0ypCJ5Q6sWkboXhxxOdt2tAkg5ouLgTPsSvbS6HajsUpIs31Sev+2am1LwgaacahosFJd2cbHaqu
1T+69GRWxS6JBrxxQwK+XwRyeNZHP6UFxcaWpdEDv0hnzSLQlqSA8pRqDM4OU6SpbCmh0Lgt5uiI
Tylh6lyK18XYS62v2vtKD6L5NloHQZsp9gDetr7un3msI7+nsAM6S6xg9akEHqmhAVOQZileOmvg
/or5SkMw13xJSFOy/uvmdg++wjZa9U7RvtS0ZkRsN2fobck8iPhq6F5H1ETn2gk4E0Rvws0ysFnk
65YNwMYghaXVsrwBR4PmIX/wKwJsh8V0tYgft95FjbUbltgfUCAMKotl8xZPXjMM2ybXdo3oBdwb
I1OK5hDRM+fvW3OtgFMH69vk3Gb47cfPvLcJrNE+6vYH4Cxsy1MfJSel2ubq9LTav8IC7C7YUFp1
v+idvxh8DrW0s+IvTVDaIrnYz0iL2udKVzt2KX/KdkDlo9vWyF/sNvxsy4YCnTRERIIab1aEK1XG
Z2IqK5MPxYDdcO8Veaum8W0JMydsLNruhKOHCUqISkKHO3ZL0LUmcZ9zNdg/Y1vL3iAvlispUeIp
evirVOhReam1oaNQsu6RDacyfQuFrlX8H9AHcc1NvhYyks6ORjAzsg9IsDUXBpC3oxsKP0vT7dDY
h3ieYfIov0HFNEHIV3MENlbrsxN3lQ/UVlUCydkIfGONZXpI5wZcKr40mNoa4JEhK48SZJw2KtsV
JeI8VB+TYvuJlZ2R556yJH0OHwZFDdxpYLxf8a0UqG4Mw5A9eSgH36gfCrHTrB9kkVrXFWlnNRm2
Xz5Eu+jcnSkmJj+Md8a4Wa1iayP11xmoBNtJijepQqWg3Xpe+QZ6KSxaRrZe9ozxc1z/iWarsndq
yMlalDYx4wkePcmNjGunnmbTZtapXZqtQ1XfqD1/xb+uJvovNJ4yFAgtg3JpMqUbn5nUsMFIhjsX
97LOXhVrMc4LNDdYQs5q/lBvK5nm5uPZrC9G/Ca1oNR7uaweL1yZkDtZGF+1wYOmvaNp8YcMO5qM
gjjWmr8aKX/mjNZ7EkWBlkBWNKBwmSxsZ+mtHbVBNC/9dWTCdDMzjn1DwtGO57H8ycKveATu5BW2
ll9EBhMTdpHix+9BKRZZ8VrDXwe/wx0hX0YRmOFzqJy0sI8vGc5NDRXiTZ/Xn6Qep33avVl50OfG
r14k1KyMgY5cjC4/H6V8pZ2Nid6AMYdYcfvayfqXxFAdg3xYc3Jy1LiZ1m/7h/KOvGu0IbON5tfy
kj4HYrhUzXGJETyhXrXUApa/cI243RoxSmyPeDtzocmBp2szES71GGpL+AkZZk/a2rmEefKdyxfZ
CRKuFhWIzNZd/0tI9isUjlfhteV0WqddEh5U69zpqRNxxGTj29heIZ2glqcCItW3S5A3RKc2tlxH
UnR/lLnWYGjiMfs3SvE5YxoX7WGW/g2T7XNoPyei8aXpVWiC6NUJb4LmlpmkP+vMekWOnGHsOGnz
58iw9G3frmSAMP57VTjAmyrP/PdHNXYQMTEg89JWWf+UsIkVxXqMFJK6wSk0QKB+TKFVl7OVGw8V
kxIU8javPteFxI9ZOO2qOory0YfV3p5zfg5csNmnaaKd4jd2DzgQHlL5KwYEsGq3McHke7walZYn
LmD4uhhYTkE68nVv01+trm5RxxAkBHkXVjShK2DtTaXfwjJQkKJuRGifpEEc+TX5MBUAdpZsx3qx
2O92jTVeZnnB3TJ2SU2oKoR2mUNci571syEQxegWMAfNH8e/uDGtK8qAZjPG5XAZYhB9jv0ZXiuK
lcWVZXweNkBV+iQPaeOMtXgzkaFg8KgM/VKXWpDgc9m3uJIxrkjl1iqoc5QYvIfF4oVdEVHOahi7
j0Sn97om93dZ79k6Sog3tkovl1yAoCNt0gdqdJxpcqpNYW0aNT2XkpcjEBkqAuY0jXXRlGAWZAvX
Y95u1VFC0jqDATKIPQ9SdIvG3F1mzXrq5+VzlsANNV1uXUtFPVyZ9rVRqE6z5yuIa9be28em3KnR
X2WTMp8oF41BVNRT5lS2eVE7WOX8rIYvqNRzL0v/NRSOzPeh5dKsm1toPWsEWKMnHGSaBKy3OfsO
Wb7a5h5PHwqHW2y99MZ91kF1lVcZ0DB9KILuqYAs1vhzXB6bkz3hHQjjpnkyF0imUM+VrZnE6meI
W7WAOI1WOLkqDF2b4Uoefe2x3A0Q5+Ha2CCp5m5qM/HZr403qQ2G5vBlTsatFppukc3Ki2z9hIPk
cC3oTZK8IZGil8FAkNFqtYkieJK+WjnCgZJ+dl3xG60xKNm9Xrtdk4ZvEvCCPLwkM5BsbCC46fQ8
28bmrPL6oOqtZLfg8dtwDlm6qWAEiJ6Esc3l7yWmZNDS0BVr30ViHQEvhtWSoZOZTbDlIH3jHNcr
DkwzKMs/rTQgGHsiiWZlOMhzrBAW/F1Nd2PAJwQmL4TNfZcF3VJsDVC8aPisSEkf4hecWMjdUSGO
fNwcD9PrMCENFXLJtpK6OoiKusIOmSLZ9ozRIOhgU9Pjp0lbv2yeoWVzNnnb+uhM+RqV9r+iLhig
wS+NpZDQFjzCHRA9BkXRvvUG4x2AW2qMRwKJU8lHNx71c2BiiELBLCBELLdt2Xba9CFTpyJjE0vQ
GxDahYbqRTeQf9epHr4D/HKANb+GWn+NfLPoOJQY6Shhe9mFIGNgEukqDSeLWhqnY79wl+ZOriNq
Fi1yigmUk7TkAVuXMnBOsswVlf5c8E8lW71+7HeDjAhktQ60nG6wFc8KopbWcvI+CZJwoccYeEa6
LxHfWKMca/MJCPLYjgDflnFRomqLfLqIpvZ9pke2HCr8Q6jVSHg2e/53CfvBsrysgTBR8bW8WDrR
hvXfFALkVbP9PmQt1HPM1i3hcC4MAS4jah9zwkzG6QlZe7PrctvarnYD/BqLpzIF7WMWkt2ospuj
NqA0s5QWsbG8D1WG4bRz01Rnq4t4Cjt5ZC7FidLpaNNjG7ZQhM/GZAAgmfpJMq2bmTWOEp6qpX0y
mOg1K/Y7C7DYcjjGDpnNvAIBFnX3JkOcMs3bSmhnSgGh7l7hIRc8FsE0/aqNeShS2xMW3zD8F3/e
C+huW0zbaGx2CX8tpUPDP75WyuTr6T8O/u1SFYfENrdhF7Acx8NRfw3R7NQ13d6oVrpKcUKw3dUc
HWTY+zj8CFtORx4UxDVxsj7Vke73sNtinoFirdeaiLhqopXGuBhIvbFbQz3LTrP+CpRafTjsmvKf
TRcT8Q+PyWlCG1f+2MNdErfB/EEHFiefkQyRgo5tcBPpcyKnWxg2PyqIRkt1RLa4Uz1iIktRj8O5
AfFn4qKlH+F0YTytejCsmrcY0YVk+nIv3dSq3dqx5rfExzvLg4vR5mjHlh5oFgr4pdqO0n1qssAg
ydZODur8VmNGUkd63YTsWEn3oDkMJW+dfJQAIx8v/cTBnhLYMnzb+hRvhRruMt38F9NvOzZ5MJuC
WnEMbyXGmwJBnpoZqMwQJhjKIWEOEpg3wy46duNtmpKgXrD+GfVew0KAKdAjUPHhgx8En5Q0QnYi
uzLFhh15xD5fgZaxJkX6vM9Qe+igdEV8a40vKbnJhou/CPnax6J+qfW3CS+vNKS6Dh9VueIBTafv
Za7w1tflh1KllzohxLbT+osym6/xKpNfUKxObS8HKT/UNhFzHe121k4BFUvZKh+fQxTz1zSxILZ8
Txha5Cj+QZTEfXwAO+bd4vSszCyIKuTnGVTmcagvcXhjmYkrSOFDET1sk34zpF6vp986wOl0W6RX
5v2kCS+jDnU1EwAgRxNi67Bn3wCSZ//f9xk6cH2anmUkqStKW3sZtz3LiWUl+Ua1ypPaLO6qF/sl
1tUrfVloYrUez2TSz541oMBVlIizO1eCWl++Vcv8KtVPM7+s1uDkrYTARe2QZBV2dLL0+RMFe5XZ
3hgiIg9nGVS5ekxHVVi8Ki1oPiuwG6X9wHNRPpjwR7oDk81cL+y6xG5oJVTWwk5cR+ZWtnylpWQx
QV1anujL8Xu1dUzeZrLxhaUdsgJyubfC/ZxpN5HGfqZrbmTPGDGCOg0UCWUp0vZBuGoblOlJssIr
Zog++Z4m8zla3vXoB6svVD5bqKFLrhpfFf05lbRLB87emvVJmmXHEJZfGbJxNecMJVRsaj5LHAFO
xeRjRfyXTLiuJhLaCisVn2aYkTY7NpSB5tP/x3UpR1SqZKwnViNBnDVYgYeB70mf/TVGc4Rhci7v
lvWJ8m/VvmvIAg3Jw+jOEjMMB0r9ZhnrCzvTzuDWKRW4ETuSTyMmKKn/mtfsZOaHpYHpiCo3KXOs
FSaioWWbzUsQW9FJQmvQzOlRT+u9Gul4ZGbdH2pVdfH/eLnegDrJ+yYENUjq+K3NZI+WYz4CfCcJ
iuGq8/tiOkVd6ETQK9W6oMtfU1ezTDevJjR0XaN81qttxEArRLxK985sncHmRN3S4ABwvVMRt020
ARi41dw8AqQ9a9MHB++g3K1lJ0K+NAebJcP+dY2Jb0G1fmXArqMbz4ewn9FzW93OZmUOrZe6NGBj
bqvhz9VTzyShNIAGog8mK7zxfpUycXrSb4VIXpszpxUDb0leI0y0a6RSaS25imb1ThJ1fMBKWezz
biKLDpA3Td2WzT1K3Aa+ppmmvVkbV8q3arfTq+euuy1xoGmuSLRDDUKsaK99UzFCRywCXpWH2qZp
sKRVvgzrqlmzkz/Sl9hWtPKczgPG8TuWtp0tl0GkZGqwKuv3bFwnZrN6vdjSTzHfocNZ0R+OUEpx
CObVrdUJq9SHrs0XHd2mtW9QPljdVo6Vr7GrERkX+xkgRi331vgTaSvy8+TbVHOwcIm7zyYX7K2v
kuNMCDiFdNZXvLKshdp6EDD4K7PEMJ/xu4CiLN7CRb6cJV7sUdaxIiibZJjfsQz19k+i/SnGdu26
S6GfYTKhiRf8xlJzitvS1XDkp3p7zNdLK/KAzlevhTvSiue2/DDTt6XlHsRrbh3yCS17i1xcO7Vk
U2WtBUj54Cv8ysQ6lbj5Q4UIP6sztKJC61bz2Ep/GpG5Ob5ho8UG8xApDUmNN9/ycBDF5NJ1/Zae
Ied/nJ3HduRIlqZfpU/tUW0w6DldvXBNJ50iKEJscBgMBrTWePr5wMyeJpF096nMk5sIBmGAyWv3
/iIJ/DUl3gHHRAnjdgP4WZr20mvbVTZe62bKP6Yi51IQCThblYLUIkBUKIlpvBvyq0ReSeIbsa3H
PZqxJPYXIzpIVg+hdXyaCl/eOssvYOgGZCWNCxJGur6t25uiWSakubx73VsXKUE26Gz9tZi8sUiM
2NGjAroDnARIJf8KMPki0n7a3J+pJoCvUloKryUMXeW68YGiYH8bAcZzuJRLjTGiOhDcUNFUDI5X
kBWFmyyDKt10Q3eVVxQ3DkFzWQ3fB30VmsZSRpd1eFf1BxPAqAxucqEwNf3oe57oF5Zt03svTn5b
KunetKjylg6oTKiRyk/Cjguu5aT7IGqTR1pXsb8aa3ufOQ62gBC3uOJmNXXt3ngS+m8jScF1mfvA
Gx/D4tlRmwTeClSHolNXsFNXg6yBP0RbJQQga1960xc1P7mmM/LgpchOQ/1rdHed1vmjaJurgHJM
YyEcXV4qrQdNTFn7pffghdOsCO4MJ9gX9LR01Q1Vl6VWNhe1drDFYKCISggbehVuf9FO1NU1ZGOC
uwfby75B1AAAQEFggw3bOpQXboRQcmsAKhnGdDW0Pw1DI13UkB7w8i26WORTS27+XYNSubWUznCh
imFYFZ2OJGd6lYUxyiw+UVja1mRXzNbrN65d47VWcO0t+mY74hCmRSXsTjJPTV89BmXGaq88gcOd
gcaKXkt56ymq+Tjp9omVyf1+5bVGc+GoJA48h1yC7oDbtHtgolCgoKQow9divAHaGanfojJbjhVK
BeDhC2rP3y2O9t67LygCGRAnnHLjhuWzXt+WJmSJAT5Y1yevaQXZeahcYtQGZL9aPFlYDpdJQ/jV
1S++Jq/KQt3bkxZEntzmaBeZmR3ssvauJHFMTW1Uo4VHEsymcGypHItQZnrD2BTmL8yN0DkK+wu3
e/WgKDs+FzjfvXNawqTUHvKbtASkBr++5eaJ/6wBt69Tb9zp9phTCtHE91g1viF9pGTNRRKH3zUP
Pm6aDF8svATuyZruCD1rnZxXe9vFAJ9UWA3rirVWNl9s5HqA7Qf+y1BfyEBZC7m2reaC6so2R+gp
j5N7H70s4qYRqBragoToODOA7hv0H150kyQrD3g2qNBgAN0w3Aaomi+Is9EPAPrrK9ZtMo5LrXOX
YbX2q+pF1vmWtbRqK/+y4eakRcrSoPpoxZSuC3cryQz5/b0+EJiZ9zZZ11XlDuPSSmJCbNSxlKT9
nUwTLthgW7bVzCsAO4V73+mYMtrFNp/CC7JuRf4Dym/TbewANhv+VCY5cr4V6kEhN4CI7IwqNXpG
mXUjwPCF3C/UCDFnE/6xW/Y9oQSUN/iLfhCvxjTlHB+ra6tTJk7kHdmdLHwoig3EW7j4twHF0IHb
2yN4UfQDBF/dexLeGEmGjZc82M3aHb6oaLIoFyxLKK25symVH10NsCbcNMayL3+A+/bw9xVfKnfv
dw+DetG6u8hTVn1w64ZXMdhTZ9XL+7jYDN2vNFk76XNAVd78ERgUp55qqqjBd5+9onsS8drChKo7
SBKcSoo8Tcp9dqy43ye3fULG3FYnkGdw5VkENjcRm4bT3pnGKu2vZfuU6vd2a94onvEj5+yM7Wti
4JVorylNVqJ5LPx943zVCJZz8uBx62bryjHdG7vplrJi0AI4Ho2EBMZlBcs/vWusG6dA7LACZZ/F
ln6pTaTaorCR/KQsvizROE/Uiki0unYMoD1jyBY1JuQYE+2mLkFjadmwaxSbSlRW7V0rY1toBrlt
AWAtC2hXavK1EC9xOGwLuCRDjktvOY4I4LQB/8i4HDT3Qg3LizIvdrECWypWtiokABtFmOTKn/xg
+rU//vLtpe2GNyKrHVLM5j5XBTcPFfQ0Wc0Lh6J/RVov7777EUb2qSSAMaltqFvkb+/bjCgeOPBl
aRAQDdDxiuQHunNXvuASncEJDv271krZfoetjUZOn2xr80aTN1K7sEkJUYEU1lXMVb0aDrahLoyi
KPe65bur0De+UZtAcIQyd+kjIUVh0WfEW1V/8aS9C+F4RSMV7QgEPlUOv9VY4trClHCyEMgS4c/E
BvXqU5oZpL4lfZvrBLX2uC+16JBo1X2gA/lV4kfFCy5dsBmG4l0bVaAt7BwSWh3uHNvfyRFCBApr
fTaskNpoKQCmd2j/LLTyKQ/hM3TrTLlyGySjh8RY5hP9KKJKfNcwVVs2V21iKpsRG11RmKC7TU3j
O+svZLcpzWcLl9uiL3vIAkGVLJpCfFMK97sSUhamMmWaqB34xi+Tw7qM1yrAfKe66IONGRCu+MNv
LwwvUwcEO0QFIigjI0k3TMjOdNs4zdoCxuar6do173wvONRgcwxBlmKKz2MYuKnp7NUSUacHaSEj
Z4EFikjsUlmri1UIJx4PcwN2YaU8ebJcOVQG6tgHsHHn8UbAukOjWI0jtd10+FU4wEAUSjKIvrQD
hCg7ubLIGpYATJsASBGowIVGPTCJ03WlF1/cLL0xY/8W++eLPrFv8+YQdogqNc0rQJpQ2dnKjRcZ
KyQ3vqmuf+kmplhGPuQEonzKkM6CHNYhcsE4hT2A4tNyVOokBfeJGODcKzjy0jGxnA66zUIsf45f
ITwvJsnEu24BZ/CMZOKknvdZIzO5uzwKW0NIAwSfvvGVh7z+UrtPZz7gcw1vzZxp3BW6L4ZYk+ql
EF0+AURleRikHwJFNKgOqUNefG+iDmqsURpE9D4119fGsykr6aMP+uDMexxT9ZqJ2EW1TMvWAZ0z
9teTfG4Mn50S4GZcge+CpyTXRbzEL52ap6scQvIN4kzT1rEumP7+nX5eWWvmaFqcDL2OsC7aXabn
Cgh5/ZpcHmjp+wh7Tmo30GuTJr5stYtOvTCb575G6KBiginFtnbgKsIGCepvRSzXoeL84hSr/B3r
l8RcSm+ai4Lcg17dSWNYyoFIzeGjii/+8DVlG66etULdBeA/hAPJPPTMZ7975AyF/AQlc2nDMHPz
HuuJZhcayj7WK+D1KL+PDREtxHkmtgYXP1mY3gOOJFaJwlnByn4WLbTKdFc05U6N6n3qK2CRdExa
iQp/xdwPZLGX/F0fw7zTqOKeHlLtc/cMbe6I3OZRnCWpGDFi9K9uVsnevc22weLn6qnaRfVCbIGW
iMVXZQm1DqzsYt8t7puVvSA5vfS2v73lCxykgwALvT79RtI8MsuMSQb13VD7tiIrxfK0K0+2OzSq
BBgPpfiGxPy30pKL3NFIT3prUndTEQxUK6jRIOxgKGnE5cg3Ur2Ia6KzfUO5qiX03BUI3v8Mq68B
sXmCoqlxW/i3jhrvLJDejYfq+kCVqUPAVBjyGpjrbfci8sfYuOx/G8PUgIVg17hL0i+h9qSgkpiv
QbN4N8JHtWqCB1zLzobg9LUFn5eae/iuerMG7niH4/TauicrPfqPg7ERyGNEyIUeFAKaZmURAlKB
Zkrtve+1CiIcOBDkxPWow7nepB0p7y0ChV8mOiV52t+dBdYF6uESZxdx0F6QoMtvu+ZZY1/m7GJy
JNFlTMFnzG+oufY5PH9lDyCztPtFh4hZu3DRgkrJf5BV6p6sr5RvDe1K4xgjXmzaHaULCG9Vd2Gi
G9RE15NKV6I99IjpAiOTv6qcRcAd2AVOgO/YCF6i+2no4JH9ZhMk4zUURU4Y35cLIUwmuncblx6c
IP0plvptEB68DEyMc5MAP0SQICRFVK3r4aKSOjjOe1teN+4rZjZ1f6P1xdoofo7pJZQiKtVPJRws
E2OPnAWKkBKsGJVMlryPWFJqcV/qQYPytn0v8/a2bNKfMrJWDncelSM/SbnjoVOHNsRwGRnOkptE
UK57lAK4bBLBLezwp3RxRO/zjU+NFa/r3Nsl7nMlrlMCaa7tuW6jXYv0lUTNBFjTLorZdbRrzrCR
7LwG9DblraJuC7oUWN4YomOSEyRqmKRpXwfIADC2wuqxHPZNeilBGJRgncHQFSG07yBk/zSa3zai
ba6A7qh3SyypzZFsAEZ5cBis/rbRD0lyhwqM6l04JhI5wZpQscPRvYKHFsGM875XMvhm+/5TlO5S
sXTyx6i+y1O5Ulvvi0Lcl7QtlGeswFJ76TcwSyrN3/ZZtAD8nAOBbJLs/vR6fpOV/eRgNGZSkEyR
1naGHEgnaizQVFBuVNrnoCLOBa3YAmQ1qfj5BGxjrN4p+k2iwvpGOZI6eOeXC0AuvQbzMCLnEbuH
rrB+Kzr45qSeyBjPOSkuwbWSOL5Fbt2/A3iMQMKlD6AZbkXUAGA0yyU4zsIimmF5RBdqVVGuOXTK
vo4Pir1vk71jqsArHmIqbjHgmLi6y4fdEFa3LQmh2CFVnzf1NiZxuzB8/84InJfMNZaZ/atyL13g
PgJ4f1LfkxNe53V/F/XdT81td3o/LDX4832MXLD0rvXxR59eaPXBGsdz8c2Rs1HMnCpSs3ONRleT
w3AXUpdCkvE1yTeSeG4CWCxJgpNDOD2aR6IcMRtMy/XzJlVoKgt99cJOS8jx6An1U1Hx77UwUyce
0tzO/Q7+hjGZk44vFRX9+sxpd0RIW8xitFQpu5B4KDqEcgVCUYAZhOwzJZJXBQyocwLs0+M+mfFi
Fq7pcT6ktjVGhwxGjSJvtPjidN8cORnFLP4i8NdLM2giqsAJWc5KW1i6sxm53hupfDrdxpERNiax
3Henb4NaaozTkrxyI1ZWoHDissmDuMkQ4TvdhH2kg4z5hBUOqOxY6a8ov8ACQmCvRHgNyCkysIYX
LmyQoIkXb0CRHFKwEXl0pQQvLqrjijsC0+pXSXs9ggBWXqOC/HIQXXgVRZ1S2djp3o/YklWyvjnY
8opsXtKujMRZaYBigwnFX6Rbl9Ie9yv086LK/uLHL6p674ftinzYkgO4VA8VMmBaRRI0Cr436XUG
NBudDCfmfFF/lPhfNv3GUZ5y/0WNxF05UtILk1Xrg71TUVl2QlLxSoNH3VOh37U4adfJNUCKPsfg
oP+RB0iS43XQUBYZnL3CKJK8xKQnfenHR1lSjvGT67KHnMINjwpoSDEqiHPrzDpWj+wZxmyZiZqL
tmFWlA7qra8gXAfX9puie4+6B0Fl7yboyEJyb//eyjPmKy9NuwHIhLisvdy8t8qouqH+BE0gyTIH
dfU0RRoktlaAqiJk0WzLuD09144JbxuzxSiUUWh5OmiXSlVSuxvddBMN5r3SEOOkYMFSiz2A/Lkh
ajJfr0kh1q1SgeLsuCw35DYzUmaOCOwzk/+IP71mzBZx5ydV6/mFdul3lQL3Mq5dDQ35VPkeZAIN
p4Ba369Ogs/WW4vCjikF6AYD4Uu9jpH0sPT+pYziCS4T5xcmOuuoYqZVell3EOGKSJZ3vUWUIzO3
eugcMwTz2qlUzadFB/k/AIIXjyi6NHblntm0tSMmOMbsetaoMgwFeqMHszHR4LPIs2SbDClFyFHL
xrUoulGaEfkPBUSrYWeHIUC5Z7jxtGCqwYDVqILXtEnu83jY6sCQEwBvPg6TNj6BHljSsmx2XUmJ
BvZpV+Yk5BFstIJ14pnnLOmPfcPMsqLXHVfIyMkQfOooTYGjWYpn9xmV6ZDUP9Intgbjz94ZGsmi
FVDIHHz2q3Gf3wXtc/eocN+ghvezu2ZZIdKzHS8VIEp8PnhyPgirEcRxfpolUhs7K3wmR4morFw4
X+vfUXwFqJx5+BpjyE4yhXPja4l1h75WXohPFVAWaEe+AiNSqnW0rxAOgNGMB90W5HidIoy2KH5A
ZC7FIrlFm9LW11F1hzjJ6HvgAi9Joadn/APe5NE/Od702f1MDmqRjYg5XSHSvtF20Z6yxBVIyoWP
e7SyeLCx/tKX5h4P1aW/cQBBLhS8x/KNiQ2Tyd0xWrkLotcdebXpt1bJEtLjCnmUpU5m5llbQ2rb
xkvYhTfQGK7jLQH1FWrHgGO3FAMv4m2zay79tb2BSvU3Z7A+O/dM23NLM+OrcFFeQrnfyq24g4qK
3jNu390K2aS1eUE3L/qFvkKrdPn6/dFbRRuynZewvItzQvhHbuT67HAMxibq2fUlhm1UHVewR5ZT
F5kLgrklxP5FsPEfz2yO057z2VDOwrmS7SGKprbcg3KfXmBLcDu8ILC9TNd/My+mzw4apwYIUsrB
unIdQOJFdG1L0HhpT9h1+iOOBEX67GipRVvYfdRZV6oyUR8bnG6KMEMfXdk4cXHW8uXI7qDPzpFU
c0rk1kcSJVQ7865Z6cMjdwlgB9amM3EtqC7t8WfsnAuSjsSq+jRk7+OwrGsLNwb03jZIyKNMqRT7
hMQronKIp3SrXOI4kp6ZCNNgfDYPZtu3RmVVj2MqZhwc21E8a/C8zXNddyTa02f7qqeb+RDpGmY5
nnXXFlDyEEc8PfbH0lfabC+yrMTOTL8hI1lmKBZFJRX1yHfMegl/Apnr3hyNtbCgy+aga27Unkpv
YCAyhXi/v04Mn5gTP1dErjU0A5qiJjuSOd6iH0UDPlgiCjIAhsSrBml0oQSXZiXFRWz74rJBMWLV
19BXWpjciE2l9nddotGI064LyCwYHevKTlT0PV0XCaxYOL8aRGaXcd4D3Y/1DN0CpOhO98SxJLeY
D6HKMrPDIDp0Xog+m5m2w42qpA0FVU591ecIGbGl3CFiG64pb3RrZ0y1naL2P6PaVnaq13Zn/B+O
rEhttpVSiS1HsI54TlTI8aDzzX62RNFgIY0zZ9Cxr32bD+9WR1AaJiQfmvC1KNiWoPUWKYO5bi3A
b4ZqiXXXW9VBtrl7E/hls48TWG6IvIbQq/JxFbLJnokbjqwdbbaH+kNC6dsye+ZQQcYg2NuAqoag
OBOpH+vM2f6pmJoZit4brpTigKOC7De2g3rMmaE69vKzzbNqXT3rNcwBgrgka40ebHVopVifnpTH
3n22Z4o6SOICXOyVaaMiowvnR4VEqqy6n3Eb/j7dxjGjujcLq3dTAbqpP8pR0MhACqYJQY0nWbsP
E53o0r+0nfFm1AZrger5SuoAUk63e2RX02brrUBdpihc2cN+e2yS71l4xml6WiSfbMVvEfa7z7Et
qq9lwXM9dR+lk4weqGwVlqW/NsfV33p3Ods1zaBuijSb3l2hNm1vgig9cxgf6RU5W/olWhRWmfDk
SSetju47ccZN6shUkrOoqME/NHHZrK7A9iMxPKgrkMWo5p3ukCPL4O2u9q7Ty6rzPEXydMPyF9hd
uBJh+O3pZx8ZUDlbwIByei+c3tyB4ylgCk2s9PSLjWaGOPP6xzpntor9xPXGNgbKokuI3hplYxOp
hRdynqc/4UgsImfrOEi70UPyNjuYQMM9MboL1bLkhd4ip4cXns1EZe91YqrpmUT383SrRwJhOYuA
/Big1ain2aEJmp9ZpBlk8rVkG8XIKWRRA8cBDd3TTR3bRORsNZtNk3EkjuEB3k10LR7HBCryUrnr
H7XFcGYiHBulWRyUB4Gd4zoaHmot48KQFgGasYX9M7TAfuaw5c857h6ZcW9eUO9mc9wHjqq5FbKr
gNjh1cTBk9VfKgMktOpb6+dncjpH1vqb/eS7ZopEiXUdfOehFXbwWDDwl66TubvTQ3JkSaqzBe97
oed4eRkedG/TBg9heyPOGckfe/Q0QO9enMpxrbh6HB4UNDkTq0cfd12UZ07UI2tFnS33ziK6VFt6
JXlCFT2FQYWymYqE4HJEmPXcPnusldmKN7SwBY459T1luXZb/qJmE+LO4C56RDVeTw/BsVXxFn29
66jBVut2iGklRNOqXIUtFgioJSxgvjXK3oUqUJzZwY59z2ytR0EdYUNMSwB5QcKTPIUta1drNN5L
LBnOfNCxgZ+tcgeXWTfK0HEcnK9t/D2OK+QuXk531rFnz1Z3nRiO2wdJglTBbQu7FR1svw7OdM+R
FS2mbns3EBCuKk0CIz/oB0TZGwhlZL1vRbHWszM74JHFLKaW37Wg103btiktNPUTumPw8c68+rEH
z/rFMVy/Sc08PlT9jaJf4SJz5sFHUtiwUz++cuUPsV3ESXzIIeo7lO3AXkNPXjQv7rcKliLWT+dA
CZ9/hHRmvZOPauPbSREfQmC9hfVUV2dmzedngpybzDdqOo6+6UQHe1S2OiIcJWnnABl169w++vkp
Kudm802sl0qe0kKjoMleo25x6yq/6xI9Sy08M3mOfcW0Jt5NnsELyDAbAd0DwbXR7yOXsjYV+Ww8
Z3x9bACmv3/XQmRmg6n2PtVamTzFVQ1GU/l+euEe66BZcOOHmuKUYxQfxpf2Qf2Z/3a/QTg8/exj
ry0/vnat1W0MizY+1INpoLIlv5a6cubeeey9Z5tZjQiHZwV0evNbX2O692Ru/LvTr33s0bM12wuA
XkXosbIwDaA+BaRM6miBjKGJqRb6sm7s/L0emjvDW3liNl5ND8FvwBKpgZJ/+hs+3zLl3PY9LXC7
QmeMGVMD+rhMN+LWSS/z53O15GPPn/ru3Yx0mspIbY/uxzVRfcDna7IxLuF0LkAbnP4E9cj0mdu9
t3kW+OJtiI1Fcl0957fKF2oL2g9t6X23d0t3DQjzdFufH8DSni3hWvmf2SSYTcq1iWRjfkAebnv6
8ce+ZLZ+dXRwPBUCG3UfiT7Dz7h6Ov3gI5kgjGM+joPrVJkZV1l8MOQiuwaCDBIcT4IGYO/v4UEH
emys3K/emdv5sW6aLWglw2cwGPiOiLT/U/mgfIErSrFmm/3NBmarurfLjiI/DaBFMqLcc21+lw8o
5I3Pxpn97miPzVZ3VCiqrYU04T33L+lL9Fv/Xd0pX8A31+rWfqkP6rmWpl75ay5Dzm3SAfJYkuJr
fOh+R+MSKB/EYtTMvkgdo/Blufdfm93paXBkfs0t0kNFmMJ2RXRQUpB31trRlDML49gitGYL3e9c
OcQTmsNXUMDJPJzaKoOLKMpy1GQrAXc7wJsiTcg0d3DnVkpt5WvbrJrrusr0bRbX2Z5z3l2f/tQj
G481u73oZpXVWq5GhwIfWUB337xHY0LELeAZnG7hSNwv36Bc7/a2SnQw1zEzPKQvcL2BUMb2Iv4q
X6w79xu3mNOtHBuy2ZbgFJklsFSID5ZPZpi0eVaWZz7g2KNne4Kfiw7MO+8vyOonFpamoXvmrT8P
86U1TfV3XSMSbSjh/7Dtj0yzVIHZr7V5j1JkV6xOd8yxJmZbQCYs5CHGNjq0qHnBk0fSw6SEcO7q
eOzxs+WfNOmAny5hc5JQj7scgm3nn8kTHYkb5obaidBqLCV5dHeHZDeGOuWqf07uT3fLsXh/bqjd
F4Gh2B2QIDwb+4f2FmzO5AZ9U/+obtof1c8zzUz98MmmZc7We1wEyF9EfAT+bnjHDJN3xAIZM3Ub
UH3DtFk7M0uPLOQ3/PO7qdQHruMGgHEPoFDQ4DJqxAa3nbsIXvJz8eexlTynPkzm1TpqdwS3Pva2
GK7A+CFSWVvlBvAHGv/2uXrlkTVnzpZz0SQVtst0W1GjMKXsmsY4009HJuyc/RAKtR/dghpFqyDl
hq2y8j1DKOv0cB97bflxPWud0owODOirOsdYggDOVb+8Pfk/X/r/471mt39Mmeq//4s/v2TIqgWe
X8/++N8PWcL//zX9zv/7Nx9/478PwUuZVdnvev6vPvwSD/6z4dVz/fzhD7Bng3q4a17L4ctr1cT1
WwO84vQv/39/+B+vb095GPLXf/3jJWtS6GlfXr0gS//x548ufv3rH3LKj/7n++f/+cPr54Tfu+9e
f73+9Rden6ua39X/qcIosx3V0SxpGFNQ271OP1HFPx0qqppj2JYupDZV8tOsrP1//cN0/ikMB16k
0FWhGuaURK+yZvqRYfxTQ42AO7lha46tU238nxf7MDb/O1b/AY7oNgvSuvrXPz6uRdOZXsAyVVPl
YRw/85xmE2t+6nQOdrh5P6zrvLHu4siq8DYZsdApVfe3DDMTIqGBh967PvrzVd43/XF6/9G0jYu8
LW2dd9Bn276kfOhUUW4srZICQSL1/BCgD7ayczU9c2X8vCmDUbDpTDr046QXUvdVORK9UJbDaRi8
yTIocvwKWkhgp7/q47r646sc4WimtFRVynmBXvXiqNQqvkoNfH3fNWRD9UIf/q0D589WNE1XdUPa
wvpLGiXxvNDFIQ6PY9PZ1drgbtpB5PumSbHHSH2UHQ0PV9gzQcDHc+7PZi3d1E2p6joz9mM/NoU0
4zBEo7lQagiBDYH7RSJi7G8TDcZMB//O7VBUOd2ln42ew8Cptkq7jjGbKE7c5V05KUMjDogVlBiQ
bm2CFJfNqLo43dTHa87bB0phaKalmSor8y/FyFoNBhVJqGUhBzDuZmL623CMijuzxONSl0GLYVbs
rh0bqKqb40p2uv1PZg9zZtoKJJ9rzKt+aeCHqh0zrm2PWK7MHJSNqlLD+uN0Ox8TV398p9QMyxZS
ciLOAcmtaHoH5iWSE2OM5VuN8JNCBH+Vp365osBsn7mmfDKEUupcSTAsNdm5ZjGYrfSR24SWvoyE
qkFl69rFMJjDo1EjDHb60z5tCpUJ5L1s09Tm9+NYl+BfbaisfVe8xGWOQ7od13e+cRaA9dlk0WjI
cSyIjgzYx9XgtqFTlQbXSG1ADdbSQjVYmomngqcU1UOCbJC97AxUaETkqtgDYK90+lM/WY5SU1XN
Uk1DmHIeuVkKnq6KBNLj51J5cBA4W1qWP1yUiFrki6hx3KW0oMOcbvWTI4MpqpqWg34eR9BsE8j6
IYcxTwejWQd90Mt89IA0Y8N+o+yjXEEoq3SMTY4Q8e/TLX82tJpF245qcZ7Oy/hJG/RNHVNIlinp
+lhtwG7F0GvtwlHOdO2nH+kIDQlI1NP0+YRVq6yvOP30ZW06GUIBY3jRmz3Z0grN/qTBnqOFlx4h
T6zDqv+3P5PtB2qiYWm6sOdIiwCcuCdy/LBSP4x3MJtCyPlYqQZq5p9Zl7O7xdtGAL3WMg3LMIRt
zje8Ch58pAra8kobqaICuL9lhPbaGKS7gIR7FbuB3HZVYd5TDxdYn1u/FOFnZ/bdWbz+53vQz1xT
2R40fXbJF7bTtqPPe/haz3x2ffxSUmcd+BC+x7wQE6E+QTsp/BF2CQKFjXg93emf7IiEZ7wIWHvB
5j/NvXeXk7pJR0/4ur6sUpjjvWJEl1rU+BtT7wHQa2dhNJ/MZc0ydN0WU3CozcsUeTo6rW50TLAM
hxIRIGwmDGSbPaGcQ95/sk/phKBECcZbsDf7NIRNS2G4ib6MXaAEmdXaqIqqQ3dvdk154SaGuSus
Nn+18i6+KVt0Jk937SefqquEuJynpu6IN4rzu64dwFdVKbVz/JWbhHKJYu4Gtil0YIdie7qpTz7V
tqeY2DGFxrydfv6uqTyv21Qovo7CuiFucg3Fdc8jR6qW0JpjT8eW3UDeNNJrULMRZt6nm//k+H7f
/JxcnJej4mUD986qnKash/FkUQ3nSpYfp+pblG4ykgRDmsWf5gRDYQ5d7g8YcqXxpM8gE/OrLgr0
y6AeYmtsRmcq+x/H78/2NEaOmJbzZs6B0xS08zqVIw4hvRLhFxyKIj/gZm2F586Wj+P31pStCcs2
bctS8aqe5SKEhOQeWk29FjmmgwgoerC95HOU6+6maoV6qTt5tgK94iGI4utndsOP5+mfrXOyqXCz
uWDNQTFKo4oqiPV67RpqzU40IDMpzWrfCKPEK7hDINuotNvTc+azRqfLIbNW6lwaZp+sNp4ySLRO
1p0aJhdx2sVrUelIzIkx+m3ZYXRnjc05pOrH4+3tSx3UzjjfVClMZw7udsM4tKMoL/HkQIMwCjJj
F+SDuRTFSEGqtjKMizzZoPWba2c6+ZPZ67AyhaoTNQkufx+XaONyqU/6tlzDZ/XR61RwtssR4hKt
pa5lMYqL0/372aeqKjc/kyCJI24Wrlh+HYZSduVaFfCi+wAVHcvoimXem+ZVnMUFFuiaUn7JUXs4
Eyl9+qkWEQv3WyLfeTkr9pUEAilDO1hdeGmlBVTsuu6fGl5iHaILfaZrVUnf/W8K749hVR2Lzc1x
DDb82fYnWmmmqaeXqLlqyOInkzC06Y8Ychpj/phZZmEvc4kByaQ94r/6qe3chi6nueZqw1ptYVid
e6UpCJ6/EukTsgtYVRjkOj4Od6T0cQBhs1yjMvnI+kI9yiO/4IWolNUORrB9Kc2r0NM0nJvhO6Gf
om1sHaXs09Pgk03M0Yj9HZOzYYpcP76H1BRrLBOjwjrHQv4qRZq3b8NnN6ysM5Wsj4fAH4NgCCY3
p50gnphmxbszSMHswe/asIaqZTkHvZPZtnXz+tvp7/lsboHr1rQpOzRdQT62onLI+YOJlbRTIo4v
AyfexGJQH0Vjwh8XIGj+rVP8z88ybMNkm7INMgAfG6yRBLcCUdTrvozTTQMAeY8ARXfRaaG//fe/
DR1S/rNtKZnLH5sqNC8dwgaRhDguinUurHQ3pojQ6V7jYGBUF5vT7X02N0zybIIysCmceekckeik
yzSzAhTXdpsGRNsuN6GeuRLjjdNNfbYbEfCZOrdh5sccWaojvlBXvl+v68xEc8sY04eswgEDpJZE
PhHBqFDF72pR9+hNnW76LZc3X4omgRF3fv63xWwpjrltmYMZVGs7MZHGpqCzxr0bXKnV1hupKKiq
I6D3MgR+tfPjERNqPE8w46wzQMK+GyN762NEmfSeZV+asSTJpCs4helqjXFnbA32mcDjk2iA+5dh
OCazgRU127qR5HULCfBgjVCJenDs/qrXhAqsIfVvsqD2H4DF2mgCVUOK4m7vnNu7/rqdOkKQ7bJU
AzkQJuPHeRgb4UAC02Xv8iNlEfsNhoptERoeItWZqWKGViHkr7iV85yX+H1UTVMjqoE3ydaJ0/Ix
NEbt6cwgfqzSTMuQ05NL9xTOEy+8Xeje7S56nhdtbaHl59oI1lFKtBd+aNV74brBRgYlHmhBl3jL
SMb2HdqA7q2PPtj302/x11k8HeEmPUPqlhhils5p9VzrnKwi6WFYBTL+EUZFDh6msgImCU0IydWY
ioU6lOmZpTq7KP7x/dyWUHAm4ULyatoX333/SC7F0huFph3L/L+cnVmP3MaShX8RAe7La5FV1d3q
1tKSR5ZeCEv25b5vSf76+VIDzBVZRBFt4C4CDCsqk5mRsZw456G2uuXKu4X2eVNH9X8cBX3MDk71
d8IL6/hsjLb+QUvU6Y/7G3DrMTyNM2mqhg2FJhXY9a+InVBbKvqKEKDUTmDmOoLsQks/OHM1P/4b
U7hSzyYkNbaHkNtcVX2IqWwx+x+t0lqQ3rQIwnAr7YMLt/ddbapJLifeBdK+uXBTBvF0Snv3DLMX
dNgziKIeOg0dZYjKM366SVt+D51uRHSt8VDsur/S3W/Lu4kr9nSiEHfzxAi0CebMi+tzm8Woy9qw
+yVqpPpd3C9nVY3qd14LtXI0dyWyuS1Cn6X2pnGL/zteLpkHhZdfT+smTEhDq3F6Pa/P6cBgVYTQ
DbFSbOvvFkutHrQcecr7i5bnde2UPSJwOjrsNw2KbcY6zmNvuCaSl6ndwqHXKCPMuMLS/N4Ry7sk
0kR1sM3ybN5Y9FQoBfCrEAVvPnKIysZEK7Y4j1SZgoHn+2VOC4eCHcwuaU0pePQQAr6/zL1vq3Og
KDZjlwRv8/jAtZi6+phVZ6fvw6uRW9mLMLroIiyv/YRKE9yW3phrwRSNiClUffbeRqjp7/u/Yufa
8u65HiqnsqGwLfJ0rl6istZX59YctR8zsPWr4Yjioltte+Ahdr4rrzVtIBps1BB/oWtWfkqj6qK0
zXnMhuifTvfKp5LpqZPRo/9idelyhCTf22EZcZLkyGKPsQUjdLleRbNbNmeqwaMVKE0fFgG0lV9C
S4HlR83N8XuDR63PCcWgKyCLsEc0LXTy85t32ZDlJldWiA3L29wh/gmKCVbSnPHgHpzhXksjTJha
YDD9EQf3je2cZpZqcarQ4FF5kNaeeIFyt6mGsTln6IIzAFIYHxd7sh4yz/vEExBBbpGoD/dtyhuy
uUGGY9I+8QxuLSx8a5vIP2uA4lhglDXax2m00MJxjSNg/Y4zpr6DDZmjU+zerCyt+OXWbEG85qHt
PfdG9hRmCXRvDsEZVL38M1gjh7y+Lm6c/ovjSzCMh6APhSTGZomlYbexJRyibwZrnos6GaHkHCFI
KU2hXe24WuwDt7RzYYglZDuTojsneLvcfnSq1gipMjkwycZzyoCmmy0tGmI2Y9TVWF7vf8UdZ8C1
9Gj+UnS21O3AeT6qi1rM1ABrJxGoWnvu+35aytfatNw/75vaW5vMf3lWOKPs6/rAGHWn1UrmEEga
ZebXTcZAXIhcr5a4kIraVXkQM9wGzp7peJplaSbxorvtTPGdnNR18+6MeiCEcyaXgrR0dvzEgP+2
t6vpudValF7wxeK8zLNzUNTa/wEu+Q11Q87QZsHW6MQ8YvyAAf6Z722YD886jG6gb4biufaQmrYQ
2zkNpVP9mbb617dvtwuWwfJopRKqbKynQ56q09B1Z0IMdM1Cl/kO5DEcfxzRGcfZFwdH6bbwIrub
BneUSg9/uEF1F5TaLCtHdnTJnIckk1GKEFqAaN+XMi2NxzEeoKVZFITuFATL50GBOl540P2jvPrW
AgQ/hs6uQ6nWBFuyrUKr2dQMntl7QdJM/UsrAATPLiyt9zf5xglihYQRF4g6I7nzxsuHXlbO2WS7
CGnnyyXtIUZsxvaoQXVzSXUmOACze/SFacdv35KKNepLhLyHANTgF3NbPGqtBQFqbEQP9xd0a8qg
PAiu36RVwc5tXJ7dFkBaWxUlEQu5qMRNxVdbsSU/ISwJbzZFpGfSsSXWVsGJrP2BJ4qe2tusBw2D
rPOpVpKBueQ0KqFkqsw5Pd83J8/76r2iak/vRzZObZPoa5OuWa3rkhQinNrOyAUV4Xi2prm+tJAH
nOpiUg428ubyY4kWmszbKabggdar07IZzQ4E2QKKnzEqLnbzPk3L/oM6WeOLWnUdmn8eZJhhFy8P
Y9sq5tF1lBY2Cwag4uCoPcsiwpVn97fgy6mr2kpMSM1HHCwSPlpoz74TCvNrPLoD+jUm3JRmukCo
XRXNCEVGk84ExEIrYqluAKPl/S8gH6+bH0RSpanMCdPe3HzwCVrtTMsLA5kTxfzu1qDC2z5qPupR
/jor3fIZLEn/Tyw0663pBR7Y5uuDJbP4vy0cqejsTukbmlEozM1PU27YQaNG/bvUNhQU1zv7wPds
GsokUBj0uD80UwGX0VtYb703wHshBib3KajJykkeZo96kUDQyuXiCuewdqcgfGuyTBFO+hg4Ua3l
Vw/tNxhdVZ063/2937nX/CLwIAbtK5NIcf2LZm3Qi9JBvE2f5/SxatDzrNXZO3tctwNTtzG4BNXw
zPOZqcPz/q1t6XqptZHqzoFBi+6cujFScFU2vptHs7wgLhXDkQeR17JMc5CMPTJBc9e9/ZMTmXpk
ORKjdfMFRkUtnbE0YPF1tOaxCrU80EMTYciGzHpCu+7Au+xcd2qK9O0NC6gEcfh6zUmHPBRkpWpg
mHEPeiBuXjSlUZ46t1T+0TrDYGpT8ZpPoEXE5C+EtebBtu/4N5ALMtyhNk2dzlj/gjRMqKsuHHJq
Y9mTrvb6SYTd8kcp9OWfqfLQULh/pPaWTLpBkYKKjGZvb1UECM5jMpL33UIr6zWDd+PJKBQYWxXb
atD2Ig5sTmWFjChaP5r2MaHOekAFs/MbSD14RVTiHJYtXc5vPi5OLeAC8PIEikvbV82XnoJNm9vX
2h5q+Mgtp/2c13p4bfRx8fM5/hfvJUGGyaa7OviC7SYwT94CT2yXYJoGHb1N5FMqLUJuzYCt6f5+
78RXpkoBWKLH8C/GNp4U6KhmXg3buBjKFhKyekH7m/P/7MZteIrSzPnWlZDUubHiQlHM4DNxlma9
n1unDSarjw8oAG79Oc+aQfVRp4rAHzcv6kyxTxvp5wWWGdUvUWKLB6JaFGbHJX+CnBCdobgdr1Sq
j7biNuyiMkXpl8eclpq5rTxmBnG18ARMrh3ioU5ujU8K1/IAMHt7owiDJPZYni4LDvD14UqQNDfq
xGSSLDGhAIwgZ0ybGCEmozGDLMOJHFzhWyeNOcJWTQJwLH3bpVXiDsizESEbtWSomoViORsGrIB8
6fogcN01RdsMzRjH1on21mub8sFVXDjLAx5kzXcHl3vToW3sCufINe5uIxEITskzgE9s4pAlahNF
i0MrgM3jWQxQQSZGbpxHNxz9OkmTA0+8dyqJ78AD0zqTVYP1ylRdmRZbI8PT56b+Aio4v3B1IRfU
u/S1XhR0UeHJuKJZmB44xN2FOtS6uJo62ftmTxeYUUpjnNjThIGFsTYy4Jex+gImPX+geXLUmtm1
R3NGNUwDWPC2s665VYhALMwrHo1OSO2n4osnlTEhzC4fka5v/77vgG6dLYU1edmB9+j0hDbOluZK
U3oV9gyUTi+6hBTFs9U+T0sBK76X2SdlqG30vbzsMaus9Hrf/N5yaYNS5sLfUyPZXMde1IWR5Wyv
Xs/eQxhaxnU2kds1es98WkR01CyXn2sdrpo03GxXty2J3Nr2Aep5ysxobJHKyaAwFzxAjN4hWg2t
Zh8GRtc7l8iOjoLkXavkc0w7aDTotwUvY/EoC0NvF4C9NJ+8yKj8OCWCqlGXepiVsblOda9f7m/t
3pd1yC1J3En/dHebrIjU8JqptILODSuEHrWESSEQKmhkx6P9n0yNCrSmtAQi2iYp1ZPZOvGX+z9h
7+sCBaRWyjPKXsqf+NtL3sfztPSxjmhT2FtPkp4MLTKYcmtl6ZGS6Y/Soz17FKNIzXhHqIZv3IQn
3DwvqC0Gim7MP9Ui1S7gPqtvGiB749RlVfbj/gJ3PC61L8oFslBggyNbLzDL1boqBoQmp46ZWFjs
0OQh7j1HzvDzvqWdpVEvMCi4U/vhJdk43LRnjk2rFniVQVynXflXtVjJOUlSqXVuHzXzd6wBvwZ8
TVgChGtLF1NlUHovieoE6mBQzDKoSziDoQVNJtqg6+MjMulbe7ggBmWA7MvigbeJc9sG3n1bSaKz
mLX84vBC+1OqKH6RogYiwnE8iAJ+zcWs/YANdodGLwE++cyW2L3OR3dBcz46t2gy/RRm4v50lw4t
hmlU36uLYX4vUCL9GKPM85jUkJ1eQ8eLL2qRTM/0IlQ6DYwn527ofiWCJem9/7Xl19z+PFIck+Ep
onG+xPpcMfNMg7xEbcvWc/uBm1kjYZNPj/et7O06N8XE+fOSE/SvrXTVKBjLmMMAzZXqWndV8ugU
zhcUlrrHXukPTvCtE6QnxwvjASHSgBDJX/ObMzBo/hE6dmGQCfRcdUDmvhciiqVGpbjEllOcmdg6
QpTeXlDqQgQOfGVeOG7P2qhppF0a20t0hvRChSC0iP00i0yE++w392uI7QibiVHAxclq29pUNXoL
UNKO5DiPxVMfOc7JtBuEQ/Ia6vlJbd4tlXf0suysD+1yDffDnISEBq+NpmiU0naz4TaeLaAuajH4
0eQMn4u+7w8ayLfvCYgAmkKkoZRegbKvTXnuCMo50mPEOfoE7fABAUllKr7B5ucBVYk0uPymsEfk
bem7l9aC4fb+cd27tBbPNnAV0kP+sLkVpIP2NE1lcnZKUf1T26j4TdMy5P5I4+rKQHfN423OMe+6
3v5UhxJBwDKqymCqZmAMPc+PN5nDH3M0xS8NEJyDKPUXjHZzbS2qJMBsubkqNdD1FlV5boSRQEFc
QLYF0ZYGJ3qi18qHNLHU1O8mJGYSUegfl0mv3zOHMb+EZRoHNRNuXxukBT94qRcBvQC1ahazi3jL
jJiy25UoGGZ22sG7qhjIOAAIvHYNPCUHOyy/4WYBsi/GwISsgetbRoLaBP1ThD2itmr5uarV/FFr
sljOUsV+6QAVgvK+v2ZDrZ8mJ+uvCs8tAwwD1N6lHp0BldQHe3rjo/CCzBrSJqTJzv9u4lMJJiun
eDHROnXix6jMuvE0mRQYM68zXi01LC7392DPIBeJp4G+lqz7rL9h2JeVMgjFRChaMx90pDme6kEX
qL6X1WONLO9BBHxzgxmIwww4XmprNp54bc9plsG0QmatzGSaLg0jLSAXgCoskyuCNy+NIBsrjCwY
QOU2e0k8rCBtV0JzPDUWrCcUkf7jLVX+2YNfJ0DIqTswKPdqdZxkA5JIDK8Pwof4aL021L/QSasb
RkGcfrjqQ6U9muYwvN5f1o1j4i/n2lEWRDXOAWm+tmL0aUtpiikMO5mWc9Xqw1mD2OVcFw4KA+4E
vX4xV6+xrkhVkOIIcX5bGMa+o4I7Ib536BttTkyshI3R2yn2mfMJLH2I3nlL314Mq+9ea0UxEPQs
uhAGCG3SvnjdNL9kDvKfURZO/v2t2NtwiZxlzJISBw3u9VbU4CE0J2IgJtIRoG9qzQnQk+jefieJ
GjhFriGH1rZjXGoTjzrSpyYiL9F4KbT8YxuOP9x69IKsMt7cjpPbS86my/lRmRev1wTdlu4IMZi+
QXfhcSqj8nloIEu8v3M30Ym0Qu4gIW+4v20Eqk0FcJGpk1qjRvi3URF7GYld/shooChojurmxxnk
0cG0846zAZRLpk+FgYH1rQBDSgyombMDnY7W2392elkIGF9r9bKYjZaee6M9qhHtW+SiUOOjsL0F
3bV6M9qawyBPMy40GxFQ8eGgZ9DRWICtp2F/sK+3J9LgJSQlo6DMLMi2zVnoTrboJfb0QVeuDOD1
j3PnWAdO+/brYYV+I4gVJM2d7XQNeh9RTKmaITuis4866g+B0Xrz+6kecmCcs+Klp0rtrANU4e1m
EnsZJEncA5yPvXnvnWjRkKHiIvSNFl6GsE0fTAiMHpLUaR6mcJkO3gp5fdf+FHsmlRoHJh+6Apu3
gg584dWdB5S6N8uz6aA/Nng6HEmaICgKqZ1WltudqsI8mnTbcXKYZtLElZ8S3N7Gs8yRqUygqw3f
0rMwiFCo8UVv6ee2c4pgBqh8irSxvRSDmJBogttcsRXjVbXA896/qHKN2z3gUhDxMg1CsL1xB/0I
9slOcXFws2bnsGliX9V658m25qPgeu/zcq4ozxPQweawMdUl0aToIRQSEYpWgVMbkDpqs/KgW854
0rr+6PPu2rPYWzmCLPPTtafrckObAJCavila7RwpBRs42PnzwFdlZLabD7Lgva0ERMLNtMAmEe+s
7Q32hOJQD6ND5qrDSVPTHD0KdzxLDaCDr7bnBuQkNyVwRkPBPaxNJZ2S2UaJqdaJhrNHFBcYpftm
pBXRjQ3syaBkp1Mllgv+LcWMpjmKw6ZFT5Kh31MY5/YpNufQb8P0hzM6byONoCMsgyl6Mdx/roW+
7d2ENED12tG4/l3XEE6l2jXPSoXxz7Z76hj19juttA98wJ6r451SDSYdqPRvOXS0GoEPx+k5lHlH
3qXZnfXRoEQxn/Aa1osy2qV1Epkq/rx/7+QX2t47BoiJK3gmmeKWv+u3va3jxepEzxhxm1T5uRia
5IpMi/eFRLcmYym9QLHr6VMNO8BBVrJ3LSjVEtXwSjqsem3ZEF1Z2RPb7OZ1c+nMvjklSZVcvajv
T0NnjMH9lf46jNul0vWFz0FzebzcTdha5paa2WrEPey8CQLdqLSZnESP5u/JDe0m0ItcL2EKCVEe
tI3IUk9zkZTvVTFWiGGXKbJCRV2biBGWWnSuRO2QOCU9euliqEZ43S1NUXkQ+4T2JeXm3i8bvege
gPxnHZOKZT36SDNBueoodvbqJpoZnaj/A+Gw0mVAXngZ6wN4w20QLQFHFE5JQThZW2RZj/RCNS58
3kYwKRRnCKIbXt6fJUcSOnpD6c+e3fi6FMjMe/LRgz2Xvm2z50D6KNZA1sOF2l5dz+i82gpd1H0X
Nfk2G2ZPT8du1Z9TrnWRP6Tt8LnXAKSeTCsrW7R/Df1Lo812d1r6xPyzcs2INnncNtY164fwo5UM
CPLqVLaBJrd5s/hZ7dSPUWE1IyrTVv4fc6ph+7u/jh2XSmsY3NMvlgPSgfVZTecFJZqWgM5RTNjI
vTn/PAmkZMm65wOXumfKomMMMoGeH9ibtSkjH2q4A02DwwP0ks9Hq0brFl6L/IgZdcfnyEGh/ze1
eQhLU3q5hFVZ1qC9G/U6/xNpXt0+kfTF+akvG/EgrGq53N/MXbOWrDiRIOvEdesVmmYEsUrCCnMa
cPmpra12ZoxyQItTrYf6T89LlHNotu6B3Z2dpXuqa5C6MJxFoLG2G1NvETG/x1dbo3jIqkSS+rvN
c6irP++vcNcSzFmkMHhtnM3aUkYhyluQVOJ8i+IbckLOxTObVkcoMvO+3re18wTzIv7X1ia6ECVA
42iQMXKXq59HWHG+17Ivfd/K7oogiaJwQrBobeevTbWC2E+vofjQIrQuReO9DpVePiUVco1vN6Xx
kWCKBQkGKG69eamApN1qKGcMWtR/iAqEkMykY3QqL/++b2nnIBJO0AahgUd2uMWdjigLTEgDkcTM
LbgnOC0u8BdS1a3H6JqljfY6i8L6dt/o3vcC3ibPBS0tUt/18igbuHE1JKavJqMbZNC8/qEw+PzH
fSt734usmjiC6i7fbONFKJQO9tywtK5t9W9RW/6DuLTzajfZvzjqLIXYBBYqqlibr2U4aEvYozD8
Kh6Tl8pqeEj0KKqDZQmVx7cviigabQxcMWnLxlYtmSNyj0HoHjxqAHC9Z2R8Qfg8NIL7lvY+EiE0
7C4GI+A0a9YfKZ61yWomPKPWpeKC2F98dfrwzVhHynVyfpepazaJI7+2gtaIO9kQY/hO3/6YxdCc
WwecXwXBja/ZY/3wLxYly59E6zLZ3CzKVrzZrF3ELhOqoc/l0JFjhbkTqgebtxPYsaz/2pFn87eQ
Ur43TK9LUc2JKa200pYnJ/cWiDG8/CmvTe+gULhrj6IuNnkv6Qit7VFCzKy5WLjGmaPXELF2ydcx
mftLEzvOSwgP+BFl+d7xICGhvGN5FjG7/EW/rTDVsi4dVA59nBYWNCZl65eRqr89j6OzxgGRcy1w
AGzeq9kdi0lHqtSv68I79QvzANGUacHsHM5i7XlCOV+mUi2jXHXT5NLSskh63fDBMSXPTkgdrs8T
NFTnGO7s0H03eeF/3noaKbDo1HSAQNrQCsnIdbWHvV5rE4c/Jz8IPKu2X7XRcL/ct3ILxCNsoxAH
El82hpl9XZvpilGPY8ZtmSRx8mtc2+aDQkmFqfXz9Ow4acr4MXtaNmHtFxMhQQUnhV9W6XC+/0tu
t5gfAnEmNWWcF4Nk6x9iDvBoji3rLQtnfDEUI/kKznl4V/UNnEZkfRdlsdyD5t7tM0A9SRYgJayW
uazNlafI2eUxtxHykDG6uKNtsw8ujJJ5ckTsfXsLpSmQnfjdX6Wz9fq0JLJh8sHUXMGvb3iJ54c8
poFI+5+zEh5Bx/bM4To9pvZs6o9bOqreSumPLlz6bBwaXyL0AjvO4pMGA8Af2VAoByXd2ytvUb7h
ryEoISbZAqUTDe6gKSKRIdWKfPqY04Mau+bB99o7JCAzqE39qt1sq2BpC0Me04hgTrwueU8SPF2V
KU19dZl6P0kaN2CK7m2EwLLeAUALQDQzmHLW4gYXS9m8Z0KbL6dE07tcz+OzN+J27p//naNI/unS
tqcPSedvE/eYjWMXfY4Vmp9gbp0yPiVQpX+ABCw7ALvu7CKHnioK/y4F1W3vbaIWNdpwXft6qoaw
KguUimJ3CbylrnzNLNGZtKKjKeWdA2nTsJfNKo7ITcMPOYvErEtevdgcvmlZ5D7R0yq/KsqknNyw
yA5iIeku1om1HJ0Fc0GLip7mFtDrWIh7FcsMP5g7Tx/NdBJn5o8dPzdJq/Omnnxm4YsnEcXFqxvr
R0yOt1+TWQkCCZU2DdOs1iZ0yeMRtdTZAalfRNN31w7VJiiZlTsv1RwNB5WiXWOyhsEHtZnE3qQ4
xbQIdVhKhoMb+LyaZDaf22W2rySs2vX+Kb0diICaxnR/TdNTQYW3Ye3GSsXR82qYiyCe8pFZoFGc
Va7E2UuH+V3Ui+zZEnAjidhiRlgRz+both/v/4ZbV4NdGlbywYJUZgs3AE+DpugCSQ7cvOJRTbT6
jDh7fPkXVuS7S/RJLLiVfSYx54zmbhFMVKweEkJe8BSGeXDrb2+FjFyYrJGFPlalr7fT6FuhZCUF
NaOj4m0ky/io92P0hCDDXJy0qu8OPuDe5uHDDOImi1HKLRA8MjuIk4EPBEtjtK+9ltkvY+12B6H0
3rIckCCgVnRQkNuyVpE6kN4ucQlyLjMfYgEbQL5UAg40UZx6LTqyd+vR2MHf7Mnf81uwNFc0lRlU
KQNnVl5ykFFfqcfODwlihUxwut97Lz7S+7lZIhPGtL8klI7q3c20hBqWQ11EUMAKHYG3MR08fzKd
9sGUIHQtqY4Q/DeXHHtMB1CQcmESvaFZc+Jy6fp05KQoMQLqbU3vxwDOwK/sg/tH/1eHZ+U8pS1D
dhI4JIxSb4JCgXusYPctgq4dZ883JxH9yVkSH5xlGKG0S4qSvtuMwn0xeOem9oy/1CTVkZzM1PS5
X2L9j0U34BqdU3hyM0j7YQIbaS2bZfEXLCD8/qKovs6F0T1odjt/opo9QuVmNOKkVEdChrs7h8+i
B8MLS8N0fTjKGu5nwXUKkkLYz5PqDGdrJP1xu+5IY+XmHMqNwwx4DMk8ugUiDMIxxEQaHuT2/N2a
3PKvKSzma5n2MQD6pkOA0MyTI0a8PasSF8ZkJP+9mQksvZiY0hBFUCnajCq2qBmFsBS0OZH1Lno6
s3Gma+f7h2RvVymcMI/M1DCwv43nWrJ0CBtbyUnvIChrU30OuinuKBmWR5DuXVP0fECYwTFIwrf+
gNPSzU4ESCDoQYCdUMluEEefwiCmEP5Wf8wHhGkPwndgArIItTYVu9FkTq6ZB/1UuFeHxlowWv14
VrI4vhheEf7P/V28fU+lQQCMJtMIsENsARiKkJ09sCuBhshue9LMyrsAec6fhlapnqdo6d4pIu3g
6c2qvxOv1c+OmlYHL+rOAcIK6A/G2OhDbLlcPCRVqqp0s6AbEydoE6MKFmGiwgsrxnsv9FBjL8zy
wOjOV8V1EhNSYefh2wJcuqJndtE1swBuw+SMwM30ZdGcjk4MYIn7u7xrimIV6E1GPYjL1l+1KRlh
nidMRa0aXbsuR5HV1Yf3ndXmB9iIXVMEJb9QH0RI8v397SVKCmM0jVLB1Nh4pypc3IvSNMKvyvao
/nET4hL9SJI7AL4QPpPCrU1FRSpxSmEGJ0zhBWqUWdcaAnPfGj3vp2014jxqUKq2ErQAy9RRWrS3
UiDakruLVIIixdp8Q0RkqyTmQRtr+WkcFBhda1X3tTocDio9O28t4FKwD7JZgBPYePDFSeOmsIY8
WIxRZZisrT/n4eKwvW35oBVGfr1/XvbuA0VUoj8bdAtlmPXSjIF6iZ2JPMgivX4qHKs5V7VeXqAA
op+mFcUpjdPmwPXIRWweXUjC/2t08+gmlOjGFnbNQIQGhFxDkc+fmfG2r1WZOY+ZYcQXL3M0dEFN
Pft2f8G7tiltAb8AUQ1Mcr1gVxNzP+oL6YrojXdLqfYnIkPLVzsj9tty+CvzSu1pEPYRcm/vEFFG
ljS5MLkCOVkb9uaydBUEAgO1X6KHmdz3D+ZwIx93dQQD3TVFtPbrmZQMTmtTFLnyslbLnOEC7dNS
qM7nanSYXx7U8KBKsWfJ8MDJkptILv/Notg0YTK4lyHLXCT+0i3KeRIgM1OBatHbPxzzo0zBE+wB
SdzcjJIaYWqruBu4Q8vHuUjb5uTlxWvTtMrVqBlg5pFU/FhvxR/3Le+9XNQl4YDFvMMQnXRPv3k6
UKfwFk4Wnm5RtCDsc91nCj/+WI0qEratmOOTk7hfxyau2pMuO+ujYrkHoereTaV3zqwVboFXe7P+
OUwyWTfJgt5MvcdBjyHvM8vYb/LyL82NjIC2zhHD200Khd+VYBM6R8T9rHy98DrRizGqZ2wmTIIK
sxs+QQPkHhTU9q4k4ykwGck6BuOfayt9Ec0i7rwM9zqID0gqKld3FuGF1/K7E1r14je9U7+fbdgt
DjZ172FhXo/pLro7vGGbBU7lCKtRW+SBOept7Zt9Mp1Fl0UPlpW1X9O+dv9yvQit4tYtZr9bXPVI
rWHP4ZM9wuwr2T6ISjaLH7ImhpU0C1DUpkzleWBF4iENJpXqTVqaR/P/ezdWvqBE7+CpqfKv7SW5
TS9VwZ6VWrnvzt4SaI2dXmKvzQ9u7N7SGAQi6ac6xLXdmEpb4XRJZRD2eIl+8irXZqo/7B5yu5zP
U7eYB+fodmn4V8nqSQuN6uK2q2+brbaEUZQFo5heo7YbnnqVQDMH0fPxvkfYswQkQy4K5iRqwetN
zCXfl2d2WVCkNTpwKpcdkDxI6XY0D07obdtCIj/4D51p+WJu/Z7XlSbF4IKIVUnEN73LxuZk0jVO
Tm03LZ9nOnx/TyIXfucNySWxrQHGsdI+6ZB3XIppqg684a0f4sdI4lRcInOYW0xhriqO2S8ZflhJ
8i9VaU2Zn1ud+WBPlKtOYVF3f0RDXUYHQcOuXSosUBC7wA62Ld9Bp//fj2kWQIz6UyhKcgaF4DzD
eASPk1nOQTFYxue3f2emNxAqkHyAN2h7jz6YWTRVFpiTljM1OGUXJ53Ul9lAY+NfmOJVgzYPL0Ce
tD5SyzRE/KV85haA48Vyk4Ub09iIm7RHolS391IHtgGnDi+2RPdvXE4HJ6k1mJiaTL06jRlj78jI
z0ETReoD8DP98e1Lk68WYBuQoaA310trE3vQy7zhtpTWh9htK5+3vLy4fbwcWNpbGYkCp0PiNW/e
q7mkpcXEWkZRIpFURWV9WpoiOokk6T73+VQeYOpu30cJFyFqZiKDrHL70Ux9jhSnctLA1prmMjpK
96FxW/3T2/cPBIyUAZBj7dtuvaZX1PiLOg1gOQXZpmgoe2e0ugZ8zvm+qb0F/W5KOr7fIp0yMfsy
7jHlAj34kPVheoXZe/wXV5k8iiYkkH5m1zcxuOAp1CIEceAQy8Q7r+zdl7CFZdQaRfjDKRl2rvvq
aLhw52xI6RFJxILf4jqvlxZ1ZaHy3CcBXbS/kWjVLwAFHLQxmDebQ/Woybuzk7+4t4GXkvTDNLM2
F0JS5VbwnMAI0HSXLrbFR8gv3yaGRsMOXNmvQhjRPs2K7QFsPb0w4wYrQ1GP7UlJw8pvIBr+LmJF
vAduetSR2Hn5GE2grkAkyk3b1sIg5HOxaMizKFqf4S/Lt+MY4fn0kIFkzxQPHoUF6pm8fhs3VYs2
i7KeD5aHRRsgBtFd5pLHBizJUQ9r75GVdUxGqohViHY3GZMRZ8x943SDfArVE5Im2k8tVMzyFCaS
aCWXCjKoFgSx8NRrNBW6DxlKfi2HsvSnwh7+un8N95YuEQoqx5TUatt6Mpk6nyylTSBrV5IP2pKH
Lzg96IrU6AgKufOsOrRI6VbSqpS0iOtz2iGIZRdLnTCiCgLTcJr2ktUDuOs4aUfYirQQFJK3PLx1
gXKEjQcVum4yjJvio04bz1Uz5q7axDvrYkAVW+AQrDRJD1LU23tvMFAMVIwpeDrBW/EHUP1OrWZJ
EhRiyiHcb8Yz4DU0XCrm+z0Nmt37S7u9+CD5ZGWVYh+L3OZpzAcDGesh2l8gjftKrbc4MzaoXO9b
uT0hsCg55EpcDlrMWzjHkAk7Z8I9DkQ/GUHRpA20WR3SO4jCnO6b2lsQs6skZtBX3bK4TyXcc6Wm
RAERuwICjsnkiTJ/cN+KvM3rmhAWqAozgM4p5DSvzyEUpLQFx1gEJexUn9TWSy+2BQVVS254zfjX
Tk6klJ+6Zj5CxuwcEB5xqotEQ7LltElTmDd3hIeSbMALjMRL7w2Xzujmf8olRUaizOaDs79rj7Lp
r1kLrsAm0kOMKeysHnthW8zAqarcL9QhevT0Zr7aOTO8Bx/w9oqTPBDp0X/VJF/MNlupe6iGCiLk
Lm3Ca824Lpyni+6HCTz0NKvMJyMZ0oOgZc8oQ6r4MDJ7+MbkAf4tkhgzg8hcCBEwL1+e9Wxwzk6H
9pVmD8qzrUfVpwS9s4PAYudWgBP+r1G59b8ZVfUWjAQACDqhduhXzeK+owk1+W2fR6/3z+vu+gjT
If3nZtzMJPdZ3k5jzXlFLHf+oWkTchpuopSXRJ+VoCs4SmXlvHmAjDyQWUSuPLVoGF83n9KEXqgS
cS6CzGJiha7bHAjoyZ+IQT3qe5b7djeDPUI0dAVkIr/5ijWC24hplSJInbnxCXX6swkhpT85qXO5
v6E7DoDU7hcnIH0v3qL1twtDpRuroRZBR+/m3QLLwrkNDaaO0jTVtAdYcZRrqKnlS2VM4YHtHRdH
e092wyjDUBTZnJtMF+nQeMvEezd97npv/iAaM/1yf4E7hxNdZYaPYWoi1tiWQ4iatBJh1ykYYkOy
LQ7Jlee9DrJkbg7ykp3DybwfPUvp2KAd2IQzXpJlc+XhPd2S7nybjQsVSbV8Kiz6fXmddv+jFGN+
YHRnfZAcUMKTflTjwV1/wFlVFkozyRTYnvBOcZmrAbTr3UPqTN3p/lbK77F+LBjmZlKcCXXKLzAr
rE3ZVhdq3sS0Pycy+a4AhPNNJqZeqeIVQUrh/6CytGsPxCZIHMBHVD/W9mYQF/XUEg+Zs+U+FblI
XuI8qhk5FlHxo/GG4sDg7YFkgfRmJWUbSfO249S5cTMJbRkDrUU0JUI3513CcN7BS7RjBRI6CTCS
5EAAjNfLiuMlM/RGGQIObP4gYRBPCBeVB055Z/Mo2jDN+L+kndeu48aWhp+IAHO4pShph96do28I
R+bMYnr6+aovZpoUIWL3HPgYBmx0qVhphT8AxWFXbgtGy2B0QuNVDYbYGA0i6nG4hmOUfVNakTwv
WhseVAF2piUZU1IogvoU7+x6WpU1VglNXRF4lalea2dQzvExz/72jBG20ohAKkeOs0UtL66eNZ69
iKC3uuR91Pbhk9LOCTfzqFFOFs57pEzagxXb+5YIUBCmIOskU8v11JJEEcQrlgDTVLh/IQOcnyJo
Mg/xjAp3OkxHgje3Z5oMjLqj1OuEK7CFanZeA/2rLgb8oYrprMdJ89SabBiqt0cw3p1Vo78Csol6
G7TMLYF4Fqm3dH3Jli+H5qlJDe2axaQk92+OnQlxioGDSaln5rTZ8ouVKq2rMaEpzPP3etr259Ss
cB2Mj3RWb0cCLwLWGk49MBlze2fQrIqdPq2IRVy1fWd2qvXZK4pF95Ox8eKDad0KE0luz89VQjeZ
K3jzeiK8NSS46U2BSOJqQBq8BK4PDi96P0VJ928YjxSoVDMq/7GIaND6mRMLJakyVUlga9XK/RCv
4r8LPJUBQ3SL8c84zvPfitsln+fYHP4makWoSGtQRHuYKTAbfj7qxhLcX57bQwUZkPICWhlSNGOL
ERngOWRGlPRBElGt8eOpqL5kNI0iv0CrxEdxHTqWNx6cqlvtA8qT1IagF6DUyobfPF0e921XxHUf
DFC9vk3hoiCBPFiLdq6FmPtrIkb7YkrX3Us7wj6359D4T3Ha2vaXLDa9gwvs9pSjwU3mKAEcCK5v
HbynGA7ASH8BIfIuee7Ik89zlOcnY8j65yxxooPXZm88OtJgRmiMs2Pl0fwlbDZxf8+0tCf0Kiz9
VCCSe/YaiLgxyElfYKd18CLcHnWK3DiUk5Nwvdw8p91AUyWviCoTJ2lAOrScvzI7ipX3RpEXJf1a
Ou5c1OtZYQsKSBsoZjCUqXetMMa90JBqD3bs7TGXmkRS3JDnmmhkExoMS6tVEaazQaS7yZmqW/vB
DJvMVzmBr8aGyKGIUBFvpg28RRCkM1D23GsI/jEb862lGP8oHCxaCcinBzusoq/3D+Pe1NCpQHsJ
3Uspk77+gDV6azCbiIprc3JPLQrlqa+XVeenhp3//fqxZBjC9qN0T8FmPVan1IINg0jV3JnxM29f
eKb0lL0Mylwe2U3tXDJsCCJVaeJEmLCZVztNJTdBROqmCvVBmTzHD/W48msgSI/NbE0nnST9fH+C
OyAC5EwIjRGm5lkAV76eYag1k9er8oaeGgFWMYk/FdkoTnHJ+XJnSzzMqIQ96tjGnbpGXS7dPGjf
7/8IOcY6bpa4O6q38GQQa90CGSYv8pYlZ0VFI1DvG6UMCU/B6P51f5y9nUOYjGaXJKuhlbeeq5s7
jkCqi/xjoVRc0FD089qtcZStp4Pvund3ITrEODyyJKmboegkzKMyh6ibcQ79FDm5S50ia5C67bOd
jcOP+zOT+3DzBYkp0YyRYZ8BkHA9s2XKEtxkZZZaWhpOokA1ReLVjT8si/Yw9xgWx7Hw/MFYjrTW
dratjMDIP7gBmPEm9gOmoelFmxFQREsGhdLIkY9IAA0Yeq98p1dY+pNTT9f7E95ZytWom+9r5NG8
LCMVBwMhoIfMzednLYqmU+2JI3GX/QnKOrRUEWXbrL8tk1YadeZ+m9QouUymPYNpqShuCJ5jTNXH
ZzfTjnwv5B+6XVAJSAVUTG/d2gImnbCaUOjQkP/LVBsUXBu9DcflCJi9s0vpw3OTElyRKmxVSnmk
zNC2qBbFOqbliRd97/PU+ZgvTngp4vDo/P2kEG5nRbGPyjfxFEaJ8lP/8qIjaBAufQVcxu7c4p0V
5+JxiEITHHFSvdWmSfmnn9s+0Dune0ImuvqIGyvhIIKB6YlbIvuYDEv8QQ/tf6LYDE/EHd1/9F2p
xObWjGNcJI46j3sHC1Yd6RpNcPy/NlXRMBrRKax5R/V4kXpTKIbnLUDLCsBRgLpzdY5EuZzp8SsH
z+rttqPczK2ocjfTBdluu9HurT5zHFSt1DqZ/cbN6g9qqTajT/E+ea8ts6s9Cqg/0cHAt0eL0oxK
Jkd5FIOILaJhGAzgIzOF4H627cvSN94zmX7uL0MYvvqWZCjJ6UPqmY7SVsba7tXQniaurXRWSri9
zlAHSjva7yylajo/64wjFaPdycmcEaAIQJmtOLmqNC1qLoJHtrfGIEk8+1LgruEneqs93L+ibrcO
k6PHiqIP8HI2z2azh0JPzZKtU/SOeen1Jfs3U0r3HW6+3bkeIP5ZPaRQVc2O4Pq3x5qRuaxo1FFI
oY6yHtmIjKaxvWQK5nqZTl42hW+qgscuDkfED8qsbj/dn+rugPgw0cam+gV8dT0ggWwze4mMnF2n
eXag8/l5lVanop30S5wAFL4/nnzO1veIi44o3Sz8WmQ2u/m0kakJM6y5kgu80p+S1hifPA1xnhlT
qADdpvxTBbDjWg314ptL++erRzcdWVs3+AFAojdJbaTnjaA/SDZom/SYo4QCrm8ULleY1/anDK7H
BbpZ+ZImoj9renOEYNvZxKsfsH1yx0bRitHpg76hoUerBDxJXwxvOms6Ij3dvkPEFbSx+L2AW+lE
r1d20jLHK7xSBFhidwHqkMiCuP0RKmFvQtx2HEiqiujEbjfsOFp2PTQiaGza9+HMRTOHArt4TIFO
9xdvZ6vKLihtCiIWKcG+nlDCv6w1U4hAzXBSDTUz88sR2cJ6LtRTrBwKTO1NDVohsQMzI+zbRGZD
2U61VasisLKofHAVLtK4r5aXGtTmwdRudaoptpCDINpBTxC/qs2+6DOlEgBNqDAW86ASgNHP9rNZ
cf6iveUtPhbB1gUz5rm8zrqK2XiMJM87V8RWQddNIDwEckITZ6rN1adsDu03dURGcL2/AntbiiIC
bWIeVSrl8ov9EgTQfaMmlPci0JO+fYjMsgn6STUOyv47xRMCRLzD4PyDCqRYvR5mGtzIazSdha7q
7tJ2Fa51CkXduk3x6y1L/OL0Wlww0Zk4sqp7chHPfYK11R4sy86O44cQO1ByIxXYPjnNDBNX5OyA
SuQI58GUtXx03OwT+a0BZTFyXp3m8LzZfF3yAILWbWM11pOhLtJoDKY4EY+OO1CyHAZkMqxQOZjb
zkUMdwAIOrcEueO246EWFbi8eRyC0jawJYAm9rikRRrgO9IHsAsTaAXq8NAs8RIYeNYdDL9zuCh1
U5JjbJnPbTa8sGHTJpVLwyWJ1Cc3N/4qsOL5OrSHZ2tn05LIgYPkcFEM3iKyG7OuSzUJEXIua4OW
ced+ijCWPACF7M4HrDl1ZtyUaAqv96zV5CaROMKC7VQsT+kyjuc4TzTqpkp98Ol2ohMKNqhhQHkB
570NvRrHKwuaMENg2XHxRSxd+ZSHnvFR0zPdH2qMqspEm/yiN19fmgLnTT2F4pQG2s7bnH9HYUcB
Oh/Q+Gi0ANYNIW5Tpec57o2DOGH3EoAGIlVjQPRw4a8/qDk7oustmn9t71Fo1oroWpRpdZ6y+FNf
Wdn7wdL7N1xERTDYS+YLz62uYlRfz2qkiokqH1kk/7tRdNWE6zZulY9BNaOV5+dLR8tJ1fLpW1ya
YKbjGTmx+9fsTv4AIBoKMURK2rvG5myYs27nS0pf12v6hKb/YGBTZTvP7oznzoQf2UkJ0Y+6P+je
MZELSy8c0VVS5vX3nmETCt0SfG/SJj+3J+WjMVfp+/uj7B0TAmq5gYjAIJOvR3FSI7HMFk88o4+s
cxgOlY+YXfN20qsjkvnuV2Tf8I5QMgLbsB7Ki+ZU4PM1BHgeI6eohbBsEzFUZ9Qh/0Xla/iSq+ZR
8r83Px4swBTsGJfHaz2oWWiWsKtqDNDmmNiUoqsCVdj6W5FbR9YLexOk2q2yO2WrYdu6y9sl1Md4
5srRhth9tK0+ST42bqhaX4xJvlJRhWaupY/5UXNo710EgEoxgCuN12MTWo7LbJo9WgtBraJRHxG7
B/XQiYtItPEMrPBIpONovE3YHmrhZNQp4yV1nwZqM8TnvGmrizp77iUajCOVsb1VhNACmJC/yeVc
r6KUFBrEXA2BAoztGwZ8eGaL0MQkoK2Sg1bJ0VibbWpMKABkOkgAUCj6eZwt76mcqYRVc3wE098d
ioIx3WUkq+girqcV9UaDXiQYAKMurC89YrKneCjU86TYr6fx0eQFtEHvTabS20pENnjKWOnszUpp
vStqd+5VbwECeByPy/0rZe/iQhIHu0TiZzKezebgAXJLSx+GAC6VqZ1LvucgiQhHt/LeJiQJYLej
0AT+enN1xVlCud10iUpNO/lgKrlNa8FKn2rHjDpEhZej8723XNLKFTokKSucp/VyudjGo1kTgZkl
QruotjAvTYk5WzgJ/aDgsTuUhDhg4brDFaG5G5X6EhLoqnN5zrAQ/czGEJQCrPRgqL3lAqBLn4Ty
KAnj5jO2oavjCpwMgRcO3WNJSvdJUQ49C3YnBJzc5hml9bvFKyHStbgxSkJBBZHimtoFblj2ICo/
qers4E3bu4cBmv3vWJt16o3KcFMHDAOCA/m1r3CUzsop/ZN8rro2bedeUthlv7HradohtADCnDKn
DBJ/ScXytO4bkXJFUdGo/i20FhJX1LvhQVSw+x1/MnEltxnEzXoYK89TUY5sekjOafqo5ZH55EYm
h1iESxPcP8m7g0HFknANCUPePCstKK8qmmtygqEzQ9+orfhp7ltlvpoat7z/G6OBCkCvEpkiTLrX
U9PQsFKHLP2JRKne2uGIR8hkPEX5oXzX3rz4dhjbAHuSrID1SKGWOpoCzQ74UB4F6hK2jxiDfImH
SjnIQvZSA3IPUkhSdKTmN+GHvTStXSZ8wRqPq2/KhLiAU+mZ1MJOzkPfq345KflpmfJv9z+mtnc7
yhAZ60Zkbzh16zlGtqdkxUiWNSRj/qzioIaxxFxdUzGg+i4U65oX5vS+qYfkOxJK4XOrp2iZo9+d
nau46q52Ghl/qKEo7De5HZf/CmOY/7v/I3d/o2wJcIfTtdxuZhTJ61TzeP9Ib0NIlmPyUNp2d8Hc
UrzxhvTIyGRvPFo04C0ATso+xPqbWCUE1cbhZSpDD9FaLomL3c2I/eugIPD0OiJX7+0zCXIh3AWj
APR0PV5fagnvycT7ns2oipV2+s2U0uhV7/5OJgizkA6aTEBRwVwPxfmN6VQyNbtJcWfACKr9hsr2
gAZkjbPI6f7C7U1MvhcuskDQvLYNlQizWaudtYEbVi8fKtttHko9QVSwQP3g/lB7awYaTiZf4FfA
na4nNgxOHJkjFeJBtvIjHVvrqTRn0ukow2vbG/I/7g+4Ozd6DeTNfEly3c2AZtO7RpIKVMxM5THK
dUSiyyFeOKl9ePBS7b29SNChdkD1QOYn67HI6J1qNhmrGszhY5bZvRKQEw7OwXrtjCMbrlDIoDLS
j9o8To7ezWWBjG1gjUb8aBVzc87Dpvhx/8vtjgIkgF4nydZNoxVmTzEUUUI1sui66jJUsf4YJfro
Xf9/42z2OmUcEIq8gwEgrcmf3akGxBUnB727nzz5TWeESjMlT4mlIJLd7DzL9JJBwxo2qHUjnp/s
vJo0XAdyrqWhybPvap9Uf45z1YoHo8o1MhIRw7o3wZf8icWVbpzV2eoeNTVS4qCg5Sz8MskdSAS6
0//Rlpqm+KoRJ5/6pMz1QJTIbXEp5WX0dmizkv8un43BH8LSWE4CPm1GrSE1H92OfOLcVtnyuZ3z
NjyIB3cOnKT9oRZDVkLpbFPnGa0O+uSAuW9YIpPrFsn8qa0i90EdPfCGndZdXr+axITsm5+w8m0X
IQtL06vRhQgQyE0LfxzV1nf6uj7KkXeiQupzMGyJp6mKbcsPetcU6VCrdHraFkKaDvqfkE0NsOro
L0pNONOTGx1s1Z3LRLIraD5ThSTJ27wAC13Fxej5mCraHg9jOmUfu7rQfHgC5sG67Z0+qWdJ0wdl
BELR9V0ickorGGP3bNfMogpWZN8MesIHAc3eKLIRIPU5JatP7p5fwtxa0QddiUoado2qfAdjOiKq
TIk8uL8p9qqNMnahbS+VvnlE1+NYXp+Zne72qFInQg1sd4reD3mU5KeyTOy/m26EE0MsH40vY1v2
n/Bzn/9KbVvRzqaWYX9y//fsrSMxHLUdjI/gI2wOBdjFOgVAypVjUMBaIk1/ABv7X6n1RyDpvZHQ
hQO7JTkWcOXWE29GdVLDBdN0l7LYj0Gj04XUbDb5YQdZ9f6s9o6EXEsSCepjsIzXY2VTlOWdoXSB
1imO9qJHjgOscUiV6mQicZt99FLFzX1EAKe/7o8s/+Tt3UodlVuGtgqPxSY6nbu87TR8b4PYUnEf
mfscGx48e96BZ7ZPMNTn31hAmqGQbR0ao9Dm11ONLcU1FWUgjMj1zFccxUFiGbn/2tbrg727OzcC
TEnkpyS3FV/IccE2s9Hqg6o3+0dnzO1TaMXDdbBr8WhJLeT733J3xwDpRREO1AD9jvXUWkrDRLbc
MWY3hM9xpRg463jakxFrR52OvanRXJZ26VSSgNKshxrQLOoHFAQCZzLjh5ns8NTAL36K0lT5W2H8
g7hl9xoAtIXuNxEg/F75g365boj+RtROYUMUdHpOxSBcxPGn6bmeyiXyx6KbvpSLOf9tOTj3+YaY
0iut2uiDbWTl0WnZ+86//pbNyaRS15kRFflg4NsgmQ+LE/FgC2mUOPqNZ4M7D6jLTw2FLQgkjo2h
sQcINai3iVNilhpIzrS7NO1knu/vnr0LHV1geQilI9j2udfUMUUwjVw4npXslOn6+IYirPr9/ih7
/XTQ01KYgdKKhERtFtI1225SJgEltnLsczpq88VIpDq9WsI7tt3xjWWk1Zu4BKPXNdY8+5S/pv7S
ZsKZHwRFlysA8OpzGVrWY0/+fBCK/4TAb68kILPAhhEAZY9vnmodIcUSxTEBu6zt/62W1Hkx1Xme
riXnGE5th01ykTkdB7kO3bdRbvZ/x6aRXbDjTf9MakMrcKl0uzpo67E8WKW9vUcTk0xSY5HIJ9ef
r6yRDtKogQNKbZ3k1Iyh+wBa0/qjg3F7cJ/sHXKpFUCuwGsHYnI9VpsKJCCmWQTJME6fMmxLTqUb
hliGKYvfJIn54f7e2JkbRCdwxEgTQInbnvEqVuKOngq6q1xuJhHwaHSYpBHGwR5AIv9gejLX2awz
mtEQvblT6NZuWagmSq/j4MJCSkPX9G2BrHppjo4/NnX5As5XvySZ+kOfxu4godidJweND0tJ7Ub/
x+kqmKM5xCSqk2Ng6ml6dTNg9+rgHokv/IxHbiYJ7JDXVdpQbBvDJZyl2dAaTnVpJA/NLHS/dGrh
eykex0rvOict7MYPkcJ9oowJpgPG/GpvJ0amcwnfF9k3uFjbuzsE7xT3dLyE8DTUx+w/hejKc4f2
xcGS7k+XHA2chvSj2HrwOm7agMen+DosmvLOKiPrI+Qv98kbUwfrhjbzl2V2ggINed8xZufspuHR
87ATTBFG/e9v2MJbXbgb5B/oyNd6136fVFrRNkYjnxA6KJ/GKfE+dGmRvT7oJxilJc2xIbHZntUu
9GKlKACNDN0w+kht6M8hcerBKDs3giQ10KiieiCNXNY3QoQ6a5/bjKJh5/A5itMqPTVm77xdxlk9
hzGlmYMV3XmVIP3KZirFLNnlX4+oqkknwk7lY5rxDLVZi4lD+94YX1/sWY2zCWjgCsaYKVOBpO9R
X8apCM9NDd5mLMbmQP5rd0o62B5cTMgGtxEo5pv5sDiCpWqqEXdzTJLMJjkqce7tQoRXkZVhK+Iu
sqko2UbTqnXKUgmTuD7SQxnsmtNZzG0TxG21PBSzfcTD2rvZiHOp0kGgRg9iM6hrV8h0Cr6ip1bl
kzqjZN1b+JHhnhAfRIS7W1FWCgA5S6P2zSutLYAl+p5ulV0hgl7ipKz5i8v1BkwuD6Ky6z69/nWS
bXWE6qX1xbbpN7oISEcT8ZHRGDDP04WeqeJEX+wuz66/MxSxGBkKeOMtG0ubF1eZZSdO67IMwu9c
BY2bumenMo4Y23srhpcVEuv8n9q0fCR/iavNFgl5TZGXVVM1X0WzRH/g5WG9GUst/Hx/Vnv7Xobu
khyOMsn2vSVx7x0xyiaSmrqf4U7nXxVECw72xe6EqHuRxqIKR6K+nlCvKlBLeh48ynbKBVuPxh+z
tn4YS/XotdnbgrBJgCwj8gAUaXM3RdiTTJrLO17nAp8lDKYf8jbNPi+GaC/oc4UHF8fekQYcwKSk
eA2fcT21Fg56hE0ByYA5NUEtVO9dHE2T71LmOCexEePau4R/3V+1ve/Jepk/SVAELJtzZqdKXU+Y
owRRkbmf4fePmIOL+jkckVK/P9ReQPbLUNsMhGQ5a7Ka2orqxsV0SeJEeZtXjlL7NtaaJ6e3ipfJ
KQFFct15wf3B9xaTdxMNU2IHauSbfbPUaWLWCqBsaRr0Qnr5LrdaNVD1eXlJ9PjIg33vMADlglIg
SzuA2ddrqWOZiBzsCAbcVMNLa1rTRenUIz2n3cUjlZNcMm7KbfTX4O3UFBk1JCtZojO2aOV5jOuG
0nTYHZy7vc3JppTCdBQfQJGtJxSHKDjh/MXmXMQMPGeez2meln7fWvrFyAw8PWKEqe8v2u5XBLNG
f4SrGbzsetBML/Q06igOgtrLrnWPCQUkkKOW2t4o3MPsfQqRAD42WyNE/sOwk5x2xlTUzw7u5y9z
Hxbn+3PZWytiVhRLwJuTG8sN+stNPC1wcK2B3Z+i0PktScvJh8YzR76T2b8TVUluGvRQnhftBhOL
9H4ubCoYTu1al9SqCrg07hHPa+9IEZByPRrQmIlC1jOStu5pLFQoQUrfo7NuymjAKq51kRWPjlNF
B0d4r0hEKABYRuIUGHPzmNHEU8FcQJvEPxl4ZrJ411xJ7DemssTnMQS4byy1dWmWVPH7zC7xqjPD
66LPR2byezOnvyzNPRCIo3G0nnk/DqOeOyPJnWmJfwwzT08FKBe8zzCh0KLU/PH6vYOamfQRweoY
HsB6PHWuw7CwB8bLK+WFKDw7hY2bfHRTKAH3h9o7DPRDJWoCBYVbP/UknF1vhMkWT613ibwu+zLi
p/obERASVIRayAYSTW4mpOV5bGgT5Kc61BW/1NIomBWXEFbxfoO9BhkH9ho7R0qfbO6QquVGxOcb
vpzdh35qhZXfaOHwOZ/H+aBnsnNH0jigWw5iBxHPbZm9yzrqYZ4UEost+2KkXenPeT1e0EhrYTI4
7olm7JFI4c6rKk0+yaHQ7JemBOu9MYQiyV2tp6NoKOkfeuoaD1U7iJPRtdl/s9EuUEOTD14ojAND
vp0LjWYeIEN62qT/2/55DeiBHh6MwEFJIG8hs3Wq0ro+kc/9+co9ScVI8h0lQceU7Lz1FO0B+/Qk
iSm4xXl3mjvwARW91o/3R7k51HIUnjdWDlgSPaD1KHHWlBTtc0YZxPhkg6p5W+IUciFE/BgPyqsl
zuVwKDLAPGfDkMSth4tyY2yHOqmDKnbdq6KKNlAGM8WnVTNee9rg0BAgoEHFDcKjsA1GZhqXYdXX
QeNN4sn0iiXo5rR4RmzrKDyXf9SqHiUlAvkiMKnITNEiXc9K7aPCKSJCEETREHkR84hvYZleEihD
1xB0r498S/NYU+72R296tZSfHJ7MEA1U+GNUGdfDF6h7VUkH5qdA7+hMuaz5WBeSTkpAFrRlQ7+r
5Sfd3zg3B0EOSo9UYvd5C7ZzrtUWV7EiagJpd3Tq4KFfKgVrTyMJo8tvDEXmDZiNIjjbZz0/e+HN
7SyjDpzFWa5dqnO52ITsdevMBw/BzWXGrIgekJqkTC49edZDSfsqG0xHHaheJDv1Rtj90ONSTH5U
m8qHyuitD1Ay4i/3Z3jz/shhf8IEZC4JKnY9bMNPacdIq4NJqxApmHn0kqjqf+M7ymnpsLaRrdme
9dGaIhJg9kk59OXVsBQ9cBNX8/sx8s6/MSEJDeAKo0669bSNZkfxzJAJ6apTfzQKDik1NRu9ofvj
7O1Cqk7gN3ntkE3fXF9jT707zs0afa+kOLtN+t8kPPAog3fUSdobSRLz0OxjQhT010uEzLCnUCyp
Altb3AcXrIrfpJ76Zkit+rVvDLuBjhVrBNxBAkbXQ0W8e8roUB+x6mTExXlUr+4y8Zh2Zv54//vt
XP80Q+C4syngx2wplmyBZEDDvAyiyhaN3825mr7oBHmPYA/cQapWZMXBmu2NSYsApJeUAL7py2MQ
ZyTMEA/UbkzOCT5LftpNi69pvX4tXfeoOb53pn8dbxMrTHnIag7Yg1pC47Wue+WUTvr86IrQQKMh
jq91kx1pHcntsH0SqGiw+zWevBubkpL32urUpgx0pSzPlMbVU05h5XmaXFuqcAMFylWHUNONTsZk
6wfn73bOMEmlhwhZJPR3ZzNnJ7Fau265x0oUxx7zaDGCsYf1MUR5/0nNxubR0Tkw9zfT7RGR9FXK
DWTKMOm2CnieDmqlGVBm4O8GPYlSeZpIJ3wdaYhXX2XsWf6itIHWEsOtj4ioCNDY0dL+e7K+dsM0
+5MVFp+K1qkPjsht6xT2hQa7hBYeCAuYyOuxUsvOlYWZAcdc+gS/ic5N/VKpsh/5VFZwAnELBihQ
RP1JTFr3AuCcJzeDfKbzYkXJj9DLzMJ36qX+0DZx8en+V799O8ivCRC5MiDAuNsj3AwV1RDT5lMo
RvoppVh3UvFc+XJ/lNtDS+cJcAT6S1QLkJdafwSMI/s8dglxUlWHKp4olh85g/dZZPV3fezdg27i
3qQYkJSdogHgabnVfqkbLLPdmg0Vz8C1e/PSwgJv3mFSbh+JHO5NS9JoYXyiYHJT7ZwGs1zYPA0Y
7QYNsj7OMx+gaeSXXhe97YRyVOG/VbZhN5HPI9YNOIjtu9m5yDqplODYuW4aR48T3OC3Honh516B
foN5Y21+duYQBmE4ON1LKDzxI7O9Lggzr/qWlq793PWR+6wOJTmd4TXjY93EJm66afQxr7WELlZz
CMKRW3x9m/GjMdCVNVqkHbb0DyckaTbMpIWE25eOr3iZ+qFZ9PzJwHzzref06pvSmo3vs6Z4B+nl
3gqBWpCoNKI/ZF7XO2FGdmtyB6OBwmn+J6bIeyt0BcMSy6p9aNbDb+xzoEZwb2k8SuDyejijTLxQ
bZMumHEq+qdUrOlB4IKB/oPh+qIwj8o7O3fmTy0zhwuTKGZb2U9K2yz7QWkR59CHt3Hfaj5FVPOx
dscj0eGdN4GhZJpHCkDytTlTqhn3aoZZTtBZ7bBc3EbU51IlSXiKGg5wbnRu0EVJclDgv21fI/eF
0QavESJnlI4292dbYT3bZnACFpxVkcRKO0DuWji2fppH4Rfs4FINp78agUiKohrOXsbs1n5rRvmR
vvrtq8xPQVJatnnlA7EpepZdmLtdpbeBOgrxPRUm0upuMb1ptTFGdk0YX5EnKHGM0Mfk41xm4uDZ
2jlHvFXcniplVxpucrP/cq153RLCwe66oI3m7HuN+4bvxEmMFALkSGxVo3/mWowPdeUctSF29pn0
YCc7ZR14ojcZBlxCS+sn0QW1qzhBY4/Re12N4mdgDPmH+0/F7lBUZ+hsy4rlFs3TQ5KmmVIhAlPi
Z1wskekLQHynIgHpfX+oncuB2o9UnHFliXTbL62EBl0fIY5AqJjTXBelHXueZgugp9bPxbnT46O8
9/6QYKnWS+imBt5MSH7io+zQMrXdMCE5tGzllCzK/GborOm1lF3Oz/9NEojCesTGsedUUcI2iNxl
CSK7pVXUz8sbKwNJ9BvfUx5UWsE/ta/WQ41KpyWhmSHcmg3Gt8QT+ZtlqBWMqucEIlHu2e/vD7h3
ILAZobhNTsq9tJlbHdu1uiSImsa6SPywKqtHb0j+TfSkfQ8ben5yOst7iyDCEcdnJ8CgcgHkSrp1
0LLaBMjIHXSdkbRtEIrMvpLktCfktV6fNEJQoyAjEUKyv765cuemEIZN1h1Eav1nVebLi6FpIbyi
uT/f/5A7hw4vP/qnFLxQ6tgWRLuurpZoIKmyQ/wm0eZrgnHEOQIZ3CMo0M4lSgjEtGjwwU7eNvLN
WdMhUWhF0BqG6E6TljbPrYAJiDSQ0j25aGl9jYexfCrNMnuTCrB29+e696JIhhvZFSE5c968KIvr
DE75E7AgoEql8fjPMFDUa5TKvLYGdRsttt1zRDTkl73tXQnbj2wNd64BmJUksIQk/IYbYbFUnac+
wcjdLMb8Yqfm+G5sPEDK0zkpvPzh/ox3duvPIia8c44KMMn1uUQcvZvCjOsGHYv4Oa/s+MsguuRg
lJ3DyCjQtcjeLNLuzRuRCy12CECYE4bCPwY1s33PKJoXz6nr5wwbhI9EMDUx4HJ07+xtKQI8qOdc
BohfbYO8yZ3jsVUpCUSa9RC3tRuUKa2lKEnHhy7pFHpsmh5Mi1FdHHfKv97/vHuLCeuY5pbsr1HP
XH9ePc3ysDapEKSasXDlON8bwuNLLtz/VCXWX3/JSu479x0ARoLa7WISn5S8vSXl6NG5Iqnev1hF
Fl/bNh1fesoVB4/k7bLSjmckujA6gdiWK1u5XpsODaJs3hjOH2LbCk8F5ho+cD7riph7HURJiJVq
aB5JCtziogmjQTFRAkE7CDzqZl2bMOpEHNVd4FgR1n9ZbCVnXSgtly3O4Lmvzrr54CyjdXaUwW3O
qjNn147UJrtkVWz6at+0qa/YhYFOoAL7ZzDH/s/7i3/bYOVH0raV1ugUEQmR1qvv2lFaJSNqou0U
zc/6Il8jkVW+6KcSPSy3f7PYH2nzBx5UzdhXJ9t6SIz2iE57G57zM2ADsQOpENAdWf8MlCbsOooE
aliVYT/2yvAj6jD3mgczv2hooZ7TcDkqn95ufJjbkjci5aqg5Mh//0s8Cr+1SqKwg+9EDJ6elWUa
ND9HTVO9AmFHF9Lr2zm93v/gt08V8a9J6w68D520bUYH2swxckHOLfAkOdGQjE7TYIfvujS3DsoI
P1EM68TVIV0lr5Aq4DRHNmsrZo6EV6BMFSq9ibdRExaL34WGp/taHY9PfYJS+RXHyIZkegQkcxpK
e/praZXBOHtGitaLuljuiyvatjgpABx/jHqLV4Xizu7XfBrr+YIdcdT7Xal276ohd48yxNs1Ym0s
Phi6ErLbuYlUgPxWYZ6yKUVKPmSOtnMCLqX8F1VxDnFyKD6/ennIUAgjqHhRgNmma3gp88c7WRs4
qRnZqGLW3ocF4cPPrTXy2Q4Gu72cQLORHNLW4fLlH9Y7sM7S1JpbB9/zXK2al0w3QuvHmI042qOo
UcBE6Fxr9BUcevtAyRW8KK1CpOHFoZeeXvKxR7F6bvP6m05LsfOrytZj31Wr+CUqEormYohDKijK
8tYQQIX82Ku9L00Nn9unoIYxQzi6znuAj/HnRSy17qsOovSXMLXid07oijejq6hRUFXERH6Tx7SW
s9xwyhPQwq46a25t4WccAvo7jYqwLPzMMQJ8GOCAzaepHufkssRlWvsRVNroqchyWoRZhYr5ycsn
FXbYEiKci+NLlGKfnaTDpVcaVzwPRHnx9xYgKG4Geh/p56b1UMA1IjV8b0yZVj8gWoZLRqnlrUN1
zHb/WGo0kQ6ej9v9BzCC4gswbMpWtCTWKwTyVI91m0p25CSeH+HUfrKGqEBE2fPO+Rw7r45koSGh
J/wTJCGpDOvx/oey81iyW1ey6Bcxgt5MyWPKW1WppAlCFvQEQAfy63udHvXVffEUPVZJVJEwmTu3
IUIl9kZ434cdxPFjDLU6TvgwPfUrZvP/ffX9+1ejP6VPxVaJJoCu+J+PIhtAauSe+uCvujuL1Ctv
k82DeJU02y0qlL814f879vrnccRsj1XFwXe5af5Ee4JpC+BDQe3dROTYh803+2e/nqv53PAX7vog
EN9H/HjlgSpWyKd2G8KuGIBq9iKJRSbehtSub1zV1ZA3DITFbWiM93NQ2uicy0V/nsFTnio7gKCU
ldzTB4yfafb1Itfrzqlxk6Pj8m1hmli7+eRXWYnJXRa9J2MgPyKStz9pz/Qij+IuUsdOtlbmO6KZ
d1N281BAlFE/ejJMX926d75MC6w53CXW9L0cMb7JTSXHa4a57X6o+tk8y9pxf0FCx8tbZaLe82Tr
KdovX+OzP4fzOz5w8U07Nv6vbSHG5BCHe/WdGs+oo2d3wo9VS5jv416mHaOSWifP5dKO74QW7V2e
OmLsCjUiMr/tGi9925HayYd+LN0o71in6nWfy7V82udEz1BtxnBqD750++hJdJiJF5nfN2w8nANu
2jSz78FURlPhBHr5cExXjQi1TLWdBrYAlpy4CQFeEV7ZHGYIZh3Ihmie2+YSRB16Yn5YsW1yc9Tu
25B7C6jpaQCf+DQ7NS1sT5bIVMQi3Op8Xoy83edsWJ9muztHKZmL/WV9/3nTXtzTqWYZnLN3UW/8
sb5Xthk0YYhgNjbqxpuy9g7JSJ0UZuMP/vKwP3uUy8MSrlqKFyQx0CX/uZmmCSHFNkcekahuW9h2
Tk6pmP9G/PlXtXYZcVyS/LiZLiBeFPzzMUzkQ42kzy28ui+dY59KewvaJI6R5NzNjZ/ZVyGj+TZe
9IiFbpuGa96mrlMXXu/pv1Fesf64/GL/d1PzP7q85wsx++IU/idfE0NBv7JbQhBFT1n3KZlbZ2Gw
F2UGt/K4ij6vktTbcAwvekBPY6gg16jfr/BUqXE87bWdYBf4DgnwajLq3RIGH8ChWkt4FbJfy4Of
mSbJRzWb+kqQ3wC6pSbXL0xMwvWziuomOA6j35W5sJXwjk0XJ6dxnDp59EoxP5lllPx0W16OnKwd
83RNB3mCvLgvBQGTW5/P0ZL8Xt1K9+csWKr2WDuZ98xJkfTHdrLZo5zE+tUoL7yo5ERUnTXOUx+t
iz61WEKH7V2KkRe+yni0RRkP4TetFkielR7nB9Giq89xwF/j67qvK3EUvnK+NIOMHxIMxsgsRgub
AetrtllNGcoelADhx1D7w21dlna5C905/RiMDjfSaUx3PZb7KItmL7V7ck1qvzD9m643Y2u4IY3w
Ps1hOkW5Mw84PjZyeGSKNNQHK3eC4nSaNgJTi3QICukn9T1icFYV07TtE3L45IbgAMo63KWZpnSD
mNOcACXw6wkH7flMS4URZ9Nu+61sux4OOdkoRYLrzlf2Af9DH17AzezOkURM2xGRolpnWE9ahhtC
tdTWr7FkwnlYmkjTi5UEOOYmMY06iKUrn2RPtfIyp9p8LWsXL2hJNuEbI74+za3w1y89jpPOofdt
/9N1xz2+GrAw3ovG6dIPW0njUOmMsilgQkQfALXb69JO6UOZkghbbM6U/dj5z79ao3x1ceGIv0yD
V3eF64TZm2t3UR7HuBTqsPW7l8AgEj5uvVWgSDNYpZiKLRHycfb60i/shKwoJ8NY1tBzAlvlXbxl
4/vQpePPxWnd7QhFXj1ANWP8EFRedNft2m8O2ay7IDca5S8kRcd1Dtk41CfTOdhGGdwgghPDxeRn
P7Xbr73Z+uoqnYaA19Gm0VYXe+vNv2kmenMsU7u/RchYtrckkISZEsvujEXVm9W5WzcT6SIp07rG
MSqJn3FwqV5n1JHRbdTw9nL65ouOzowV/3YfV92Z/SNfTLCkZIv1Zp9q7sJpuYvCuctuIhkOa7FU
NrbHi/iuzNepbvtjrxl2EImzLcF1P9r+g2Dc0eY6SZxzWU/kB+BUU36vbC8ehjXVLTFIyv2Ien9K
8i4I5PO8kruM+sEPD5F0aAcdPEueQidq/SIut+DXYtpkysMZ6U5u8Wt58MvUsESbpX2V6JD9c+bi
idUsIo3uEk9AkpRbqNxrYjLCqKjrporqXPZJ7xcRYbN3lyHi186xPnvVNvVLLy7Qmm12+0k4JFVC
8JWxyjvRrEuRWShYNvCVpv7wQhJyBkRmDzGNkLwSS6Ue0eXH31S/JiafdvJciktylTnhZjMveWBY
VDdhHTRP0iHNLS+DWSWfs6ZOT4vLoO3QjFtchKJxl8dZ+G317BP1q4uxNkOLQy0z3JyWyEsPzrTY
lyTwTXrAgyadcHZV9jVh6NAXU1AK+DkybQdGqjEP9mxdtSfH9GVY1Kko99sxXE170+1h/cMRtKvX
bS2H7UjiT+medIqNaQGpOckOgle256m1kuSozVlfSEKVw3EKq+YBf3I4JX5JstoNEtRYVedaqKHM
B7ln3f0iY/mbKUWSHCH1b8HJCecxOift5n6zKwPeHE+TNToYrwl+0mlTAw1bHZx33Nnj4uJn+IQn
SScKrcQEPSdZE+jeft2CMobR5N44zpBJtuIerEW9o9u591l22JZDw3xRpZ88LokXfpVVhvvYrtQa
PyEPntuTHrKyO/Wtdp+3Jtq3i4Vl/5isJd+EeKCSkJSq3VnWfquuaz/qvrkXg5mCrNL5OR5itzy3
XNPrzbbYfs6dofPe985MHM2+LW8WnD4jZhX+8AFeFy7YS/Xre7PhcZ6vezJNBMIRGb2agO0yIErR
py5s0ufFeIR0WW9KogOk4j09OqMo8T7o10oXztinv42dIwP5QPfvbEt3ycl7cdrr1RfujzrctbrZ
5857JlMjmI/1OMQ3DUZ76sx8cUx5SYN5EXFM1egaP96fV1PLW4fSlIpC8FnkiKX2dSJV+8mpHHfk
Ihy7b5VdBj9XWrnfEdxWfi7ENt0bwTI/rBaHrxtsrcYBFUAYVaeozLKr2C47CiZya00+wvURp3Kd
lqxQhtJ47tGSHKDImfA2K82Es3ytrIbspZsLLJZtX/Vy4YZn3jR9DodtemxLb3Pz2BjHOzSzcNXN
4Cncvkkdq75QXYZE0HvZMBTJAnH5Zq2WsipCksEVVYHn3FCeRuiqWPV7eyaOb2hQ8FZziE3gNmA0
H9UqJAx6Ct6N0ZyF1T5XP6HwSj93dNjKaz1Xm59fTt/+SWg+y/WwL76+r1MMTt52Su7qbmCaUuZM
VvaMCMy+vjBgSu+x2b0uy+OgE/NxY1svhVy8NqAjmNKVQ+Fy8UxJuL8SVOgPR1hp+wjKMY7blQjr
rTy0ydC9u21di7zRg3ocnSb5NocdP1bHMsIRyJrtUdUoJQopOalOqsrqjEJcRu+DyMJnxRxyOi6N
l9gTtqqrf9qnZqoLLieB932iEI4M8Up+EC24ObVKboAP0i/dfEktq8OM0XqvPL0veRpab73zPEuH
eJGihEWktHghvhvI3JNKvDiON/eFhFLzzco6C5DFuiI4zsrlM22uMQ+eHtzkvFamMjcqQkjxuaoq
KriknqPPY+06U0HOZfKR7qAeBz9qcY9KfGwwLzZb8h7Ld5HmzB3m9T4qwznJd/5V2IIDuEU2+U6b
28EPADx6MZZxbtJ0vR8WAjPyVLk1nTthnlWOnnYThex8+5jMW034l3DjJ7qq9Hr059Upeh75kzBT
iQWyxKNjDNqgPYW1bxWcJzFtZ7VnCRrmOoq+ueDnWS6UET+gFXTyQGrOUL0FvQwZr8eB+lx7Sdvl
dbh4d1m87Fnud17wXgIxYHXmNM4V9kROepj9JQzOnOr6Ltn3MMv15rm/gAwiUivtTFGwpuKgbUsB
5QaiFFc2XSu3qHVUmkJFa1QfMLPwfqJbcC7fRXosYi9oDo0I0vmEk27/EgyRNNwa/qYg0lR6z33E
7F8Ry3KDNGMIZdpriUPgvuiHshhkna63AUdVfZsutR3Y1SPhENjpJTd7Bz0731ZtxInNaXTRxdN+
H/ajLw7pLNstr5i6cMMmoQHagG8GR3yZVXmeUTDPqDM0E3OoEWQLyzldrirf8ZKTN/T+56gHCD5j
/sN20NZ1n2mQquaYeH2a3ZUNSY25K9r1vg2iprluPa6tXAUVdrSC2cmrOxpvOpbz7n4jfs24JyF9
Y851u+rPiWsZKNFFyKdopZUqdIkpXB5lq7qictkYGkwugUsy7tMbauxgyH3A0u4MdOXEB83c1MW9
PWAX9wQBWrxnF6fM44txG0E/5GjTzg0xiYvaH/OQrgO8ioAEuB8R0pSCsI3xk8gi3s+I3dDHKHH7
YYWWG84Rc5lSWvbR12b0J120pAVxLLHAudQBUO6M1fioje4IX8tnZOWAUyR6yxt/Gu972zZLrrtk
h7KHnBmzN8PiLeK9jYJTKMEQchFl0Mj59si5eLKE77qq+ftYV3HPIdRl73U8px61pAlFlZOfE9dn
Ea/w/5jvqJSCjJTOvIHr/EYJHVKyhfGS5nqVwQ/V4yWW++RIjafU0ar+lPY2Y6aBO1qSR9FiF3R9
CnCf0Nr2OCdBMx4HqIZRDjsdSUmHuIeDLcsIJDG7043nFnuSmz2wNb8G3lPeuYuaLiwCFCh7vgd9
sxfoFa1XBP28PEV7uUIzhXXxS0sZt/QGVXJnBh0SUtanfcJliD3Vk+BA/zJHE3dJzbrc82aP9zuO
BwrsYDAUKaT++r/6phTPpuv1x7h3TncXNMvm4DQXWeSXAV42FxmLKGoSeN/cZdt0sYjVj5krpdlt
LbfomS/iBYWhITghxPATwlUW+y7rDbZLA4vNK8JFBAS4RTK59W0FWxwhjrqP1o1r3lRpX6FwYz56
EGsctpRdyjnUxpm3IhtN/DuO9ii7jdRUvpckkfD158V+zPhzEIw3OebnEGYAW94SJtfeEC5+kY5B
8GQDb+vB/HR7Zxt3hNvZlOpTOEgKzkXWfOZ1IkSpiDW59LkJ/G4qeqvEra8xpSvWpp6CQ2XLri0W
qcvXBWNhDf3VQHypsmoub1U5r4IUm3gdcpDNCctBG+3HZSzD4Qaz+ehXmVRhc6gmRUMee6tMrjbk
YcNhrOJpzU2TOW9775uhiIAMh7PfEUgT+3OX5lEfo7DlJ8DFOpeeYFy6Yc73ZLE12y5T1YHlGX6v
0G5/K50ah0Zj1UykOId6RwC8mH5Gepr9+6Tb2/EYZFP8yzInIU90Vy09NSVqPjZ1VR/WrAZza0gI
UlzgHT+yB8ST/fSc3f8xa8kyduv64lmAMGBkRlJtvzZRXRy0pljhXIJBTLGAin02TgjTkoT4jo3m
9g4H4ziHbxhGpr8Tb4sIuvCmtDzUix2Tu7ULp+d+jssvGLfF7aGiVWhyoNtxv9nJ3PtFOMB0nVJ7
ZUXbuu0Pz23clZu4AliYTTq/+mqt5NXkwrS8SkWwsgFd2//uVn+tjw0lWgMU2gcftm+Xb3NSD05B
5omrgGG6DBimXY29uijgCJdWe6jzaAkXXczpnDw7JmJOgoV0CCdWYGwHdXNMZk6+1LtH1QKts9cy
SHL8iKrfLfEC5eW6xKO7h4z+cyLh6Ptcj2VDL9X07QHW1NwcNi9AH8joZ/g+CXL9DsJr63Npy0Uf
KM/aGmBx1g9rIkI+RrIoQKFk8Zkn8MbXk6uX6MNVC1OCOKuXKQ+qIRnymmOmPxrrRr91HNNYLNVl
5okbAw14XUFyZnk1a9714/qOGEVWhaSSenWsciaKA+tcaSY0aY4QznA3LzPj2QY7izwQK0G3I7X+
u+50QJq7XeafTi/1Q6sr+aNrBvHZblX1daZsBqzGFfpNe1W4F6KX+9tGrLmfl6GDvLUN0y0P5C5l
4bfbck5o0qrcq6R/bzaaHRSoaDmPm/XkeSGI+cVsw/SypRW4y6jGuqGr1tyKBgR6PmDAFMsCp2/1
KU0IW81DOdhnjmtwito66zflhMNvrdZBIWGqElMse9j0+Y6L3zO2XsGrmEVzTVsw/472KXgp2UC/
rBpg77VgKAO9vwt2m5VBjGRIu/GaC+x009ylGSXqPtzSN02LuOQluMM3zxuH8gC1JamPWsXU4Vgf
j4xWot08AehsLUX2VC8FU5nePEf0otVNkO0oBWq/C76YMu6fZt9fvmWNapY7vbXpymxyTaLc1bFU
d5Up0/5IH04aic3W4VCNOhuuG2YHPyuw/tuMSMj+Bn/J5BnHsovXHHNHVYTb7rlHFIHqLp2c6VOz
OvsP/Cb7T0hxk+bU9z2w8cwA9z4Z90HCW4yxDoa61Yz5OPfR566zszjsOlXqAnKNL2SFCWatodOb
K45fdZrCrnTy2Bcc4JY7jMGYOzhu0XFOP+8eVzUa5wlEEk5chMOT6w3Ao7XsX7zYzNsN2Eb4ulMr
M+tbaJuPUEl1lUuAd4JJGb5dLx1IadFW7siaMQ7gfdcRf5fXZuu9okydrD1uU2C7wswt5mc+9LrH
1gR6u5JZ1qQPIYPD39jZ7G8DVm1zsW6XOrrcmvRaim6tKdNcvT6zBYCG9FTND6Ose4MXdbx2RZvh
k1s0jQneonBgZjERGHGZuji9d6fLYLopgTFEvhqEu+fNyF0fRdUn7ZkZvGXUue7qx7rZ6g1y7kDk
Gaa69UGUEXECo5lDigGm57/Futq7TS/7z7bhHL13B29lW6ICn86Uv8tNtA/+eLXp1rmKN1fOjIPi
mbRWYNb+PFKzfMuspZMN1O6flAh0d+hCXT8TI+s8hokKX0cmqFU+6zh5RrvcfdHV6lTHvkmgXo+O
zz9pNxLKizhaehrDNRQAAXbjujB0jVERcHg3h3ISF87xOF0SJftt+kohW38u55TLMBGOkmz6lOlV
hTXbFcjIPiN2DdgVTVPTayWbq4pSuT1+GY2+pLtG1Q8RLNGYTwvUrKNerGyZw/hjl6NeH2yOWMN/
oySJX8LWJmMxt6m9kYPyslwlkXPdLtsU3q4x3Pll7ubqqt388q3bgZHuSnwe9Uli0VtR3y+0JWGg
oi87zUp5jIC4uRLqseEuSVKRFRsD/zfcgaL6hAxtiA5zu+nyxOhWPsOVaglX8YCm1OBlZzj085dI
2+TeWKdhtNb47jUs/3pgrmTYCE2XNXceU6wp95emenJ8j/vczMtYH/upF98kzD+V68VwGhLkjDgs
bXekJS4l1KvYFo/Sse2b6RgvYvy8tz3sV6M4KnLcFs0bCkbnR80C+DHBZygLJhXiI2z8+nGcqBqK
fdUBU3E8Xs7zbkD4ykr183GJ5Uji4dK1N20/O/LkuaNzk3LaxUcMU0KITEsi+qtmbPeuiElQ6HJV
xdw24xh5d2E4zckRnwLqLXpgtMx+UpWnzPhyKEqjvesdmJ6pwqDnc808LMrn0lKuxt2ypkDseupB
z+KQy5kjlgpDwuvLOH42RsRZfZ+YIaMkinb/ZwcT4/sQYvxaNF7rUQdMeFtksuKknnGOLxi6jUme
DcI8rt1eeQd2Rpfg57ER+Bdm8xaeY691JY1DuX+egmh1i2aLh+AwOSA+VBDeXBfJYMPPQwub+7Yk
g8nPDfSS+83ZMq/QWec9LvulteTwicpbWKbDJ0E+yIVK4nsvEcUzDoBhxDC3a5sbRh1pWeBB5rwm
GkuRIvVq/7Glw+mfhd/tPzuoDun1EPbzW1pV8inW6amSyh2vrOOBjXWx8UEFwq0JIRlk2f2UbesH
A4tUXSGT6m5pgvRPp5WcDMSs8jeazvGf9nUfM+rJZYIlSgvwqLh/iKtKd5BbQeUApJOELW1mE5TH
S5ONIb5q0gMHq8yAbtZZXw1QvMCOVMsUaCMcvr0zbVByWIZr/bCFwn7R3NUvAR+ngsE1+b+HtKTS
vXjn3U1BNqCP9rvhEQ2AonStrQAnD/gztyJBK8eKGNLX3mYtLWjCMs/JuwgRyHYLbEA+7HOwCpB9
gP3oa2wTygbfiOoHjAjcnyZMP+s8wawju2esC+SX9iHwFCE3kXvYWKERx3froGeCXWIey152bj7E
WIgR/B5P8jj0evoUZgSH3c6MNcbj1qKgowWOkemqeFfEhrhb+g0OSaNOm0NffcRylMvGN6XczxmQ
+xs66eACGkd0K9vCwOlqA7Oa82lskJOVxpMwi2TShTkoeAoC5HB3cD3Esj+Ge4/FIJWe156qvYEE
eXTTOXN1Huh1i05LMHXOQwfyTKitatpJ/VKlMeWDlekqrtaxaqhySLMMNk7Rym/8Y9taB9rJIiFz
moe5Yii9FfEY6PlNz1rvZ6oWJZ28FgGMpsxC28Snzi+dV3+yYYobvd9AjMplF3MOHhPt9fVLIGO9
iNzFY7TFR3TTwaeQ4N3+QfeOdQFfuHTCq9GNUVURrulTWfeu43x2y27trmu76uTy97pquC1xrphf
Y2/Zqa+cdE+HX8lQ+dQzDP14xqQyNAz5PDjRSmu/r653FdnGX+91CITOvEAt/W+MrJd9KBgi03yd
jIql+C2yPSE7GqvZ9nbsicb93BC/Mv0kOMdbH9x0EHFhMZ637wxbjPupW+JmqQuRxZ33ZXBU5Man
tmVCeCW8ZWGUPAZ7uv907HCh8VDDld96SLPNmccYZonyEsW9cSUSTvARhI7L5vYSrPMzAqvFhEF+
asIR56ehH2tQF+Yp2D00vB1kE+OcRFdLtM/Oaxf5A5XGvKoo+TyKxWyQmydXs6Ui2Bbp91gHcfJ9
jtMmmc4VU1JZ5qGNazWCOlVh96FSbpmfGe2qONrUBtWtrap2eow2jTl2gewNy+8ysSK5tQaxxrkK
lqW7c+nKw3NKwsZ6bAHO9+dY8f8fcjdlUICFPzF+P2UlbfspLl3HfhWb5dpgUrJlV4b1za8We012
BhSfl2tvWrgyS9dnkAKktpqbzZkxdY7HpFmuxm4lS2Tq22rlqpzH+gEaVKlPw5rMw43Z3b0+LlEX
NF/x+BCa3nZMzRHMM3SvDASTPa976tdD4GxdwiQDgKXYorBPPxp2zAsWgbW9G7eIFmZ3uV+Pk53w
R8DvefsyS1v+Mnb3zHXMIdAcbNiIL440g5tLZ1nfMN2U/sm6GcnyQxfMOTL6NjnUXH/hEVOzZvgq
x0YkNFhBZq+k4ocK7o1NXEu2y8850nV0cGE5b2fomN4b0iNwpQjEHpA6A3vLkdM4T8xRZXto0nr/
uulkeEEX7X3aUukmdEljdRx1WfWMEKgR81KjuM0ZoJT3Pf32U4qNBxTmcOyiXMSi/DqNcvSKJTLT
kndKbR+dv28rheziugdv9vWPDVPyj3Vu7I2jEtznM7C663nE8J7OLD46AfuCpMvmOqhrDVNg2u8Y
Ai3tcZBLeDuwe9Z892eGN2oT5moOq7W5axOSMtdwYvwgA6W6fCl9RUYAY3Hm8gA/37vds5/UoBIg
06Rd+oNuIbYf9pK570vNifjJdcwIGI2lKeEQUVJuTDUCqAetF0P1KHm7nyqNruTQDIv5gG2Uvoim
85qT7EWSvAykfn/WpFpC0wlt9DMblmYDgIlG+ugt6voiWm1zNDKzF5OHJsGkWTbAaqslCvdunLz1
SohWd9eLu5ZXKxTm4T5CxERGRBVxfWemB7/A1o5pDd6T4D2r75Z3iNejtlCzqCV480iILxd/z9hT
iyTMdZSYr1pyNx3t1sHiqOnXuY2bjPjbeRfbFVCWDA9jOnblLRwqpyPesOraYyX2+W2HJDAe6R23
713slT8wsk/TnAJzvAmkCr3TpnX11UwrJOW0LOunSYUVg0s/HWArbvtk8njyzS39Ej0rNvzZ/UXY
IAuvi8upgN+zUbM4HrPeaelJPlAd4as5qaMjl9XShk6uxT69liXtcO42A6alCZWOOYR2s09THSyK
V2IjNy85gfZcmqTlxPMyaFZyGTnOs0xt49kDxvzMWB/ew9LgTF2wLAGr671St9JSYh0XRDsLh9sl
mTDaK/2l0UH4yc2saHOOfdaNP26Tf+coY6rcZQ70IeUYt/R4I0TuYTTMk0OwKPu2AcjeJ+BIDosn
G5+jUe4Xrl/k3w/SxE+46+D32g0c37mzN+l2LKtte6qg4r4GldbdrWGIUR5FuNT4wUM2mI4iEjJl
xkN5cUoN0/ALYgCIv0SzVCCXXqRPnt/V3WlWYQbkQ+sH5DrZpZg3b/7ac+uGRethhfMZWUW/H7QL
1w2UrUzk0S2zCmv0JBhv1QiP7MOr97Q67qGTfkuGMQ0KrXu7HNnW+CfUXd+R6m7HLLzW7jDdL5aQ
qwI3JDD1tOv6G39wAKxLjx7uRGngv+toMb84PRlqNZV7wYbAsV0aT+ulhanJgn6ra7Nf1VAo8KVt
HEay0IGaN1Oa6JNncSi+9bjpnvfOi6kE/jsp8188MtjhWCulGB+5VHN/+h717bTNlFOgrqo2p86W
0fVS//Upf7LtcfvF8QgDcNzpMmyP/mC+057ouNv7tFAKxDlp+frR4MF1auBy2C2QRYUZ+V9+tX/x
8S4P/V/6JypM8MPLn/8fuv0sPe4ggT11SMjwLYbJw+uQjOLcMbr//z+K0GTIuRhIcZ/8KdLChMdr
t0YlhfLgEwRpNZ1l3Mzn0tP9X+xK/mTRXoyTLwnt/xsHgRvdH4y8clU9G25JC1GrPm8EOQlN0lVn
9kIDYbP//v9eHxd+MInUOJxBBPzjyzWb2gXMkQzawOZft/tir1NO0L+8v//0S0FgRsbqY4P6r/WB
mr1LGltnBYw94mZXCN+BQJvcLhHT3tpEf2FP/oel4ZHi7lPBI45gQP/PpeFDCB9HNP5FFuvvVeg2
B7lCKa/m4W/WIP9hf5FqhgyI5DZyrKI/SKGo4rTSTpUVQB/mFR5Act9S7/7l/f2bp8mqyJDmsSBi
fBX+lOaqyES0hXwmZwKxHxrl3zdRCbfLJ5cuGQEDFp0uRd2W4kXH1ntnljgfffgxr///9ZJF8LxD
bkxUNH/w12nsEqQZvNnRQJcvqgyaCgytIPhbUsl/+JWJ8WBhpgB3JEAHfzzJr8u0qgk9LWDguIfJ
qwADnRIhA3fMCaden8/pR2UeQBwuImfwDga2U76v6m/mnv9eTQFWkcy4IONykmZ/bEmn9EZGKbT3
TtnY78xTGHZiya0/kN9Vfwuh/vdRysMussTg4lDPr//PpVvXoycYewCGJV56r5L+m1Kxw4yKQxS1
RXho5LL+Rdjzp2zEQ0BHphbCNizxedN/PDOBCw7ctvOqibo6pG63Mczcx3OXKXVwZLxBnlq/ptrW
p/++mv7jgxPszvCEISX3TwY/NBMb6oY50wTQgcId8jvsv+1kCSPMp7DRR9/TcEz7+W+BwP/xm17y
RS6q2wRN0D9fcx9qwoM6mxUi2Lv31un6ly1ogVlXu3aP//23/PcZgbAXc+TLDcmN9aenTBWMtVp0
xrN6+T/Mnddy5FiWZX+lLJ8b2dBirKseAIdLulOreIGRDAa0vpBfPwtRWT1FT1qws5+mrCwswxgk
6MDFFefsvba9kYep3igzjYVfX+WzT2Rw2sVsxBShnDMJOLIHlFgt5tjRaPARlzSyuiI/TCjmv1ij
PhujhooXDIuptTSHPt68OXXa2oLS5DnouE6jmIKTLiXVswKlQfbnQg8Gl21CYvi//oif3UggeSSk
kbaIuXa5Bf+24kuJTG2049Q7D2r+LVNDI19lDqT/1a+vc26gXd4HrJYWFk+DvqJ2tny0kkJMwmQ6
mAswDwKK5a1LhLKiW4GhEkEDmTSd8b1BHnkaNDv64mP+ebVESIP6HzyMDj31PBu+61XatTSbvQCe
tqfDdXcT1SKMbkicbSCLrzB9n40cwI4LsVWjpn9O4YxAcyQTxlbP7uR+TUjMdUCW0IrsNPuLdeyr
K53dWDijczzV3NjQLA0/yxWyIZI0WOV1pe9+/Qw/vdSS36oCswBJdvaCU+oKwibQHU+XYv0VfAVR
6VpcPVRx9FWI+WfPCwvFf1/qbKViD2J2NKEcr48ckNYqWaMhtTWfEHADqSa5k7/+aOezpopOcLF2
4+1eONDG2fU4/gB869LOH6RB2eBHGpFqTc46VVERatrYr62Q8o42Ze0XM9n5Tf15ZYewdsYK78W5
mzFRO1yOqtr5dpvaP/KydHYp7WAY+kr5xTv42aXAKsrMzSAJDf1sjjFh9GeTkDtstL39A7G97mGU
uBN9I311kDh/fsunwkC2UIShCbPyfpxWsqxr1DhE3ypp45FujPLQ5EPj0rgwbzI7+8ondz57crnF
rgs/BjUjVMyzT6aIjowU2+n9UYpRT5r2xvhpp8BdQUO1LPk96Ox98eTOp7Tlokwn7Nr05SjonO1T
Y6OvhVWi2bRpgF6okpFuewAl9w3u4TU7DsOnAFTuo662X6JpHG7/8pBlS8NT5ACl8ZnPXvw+pMHW
TLnw86kRG5Guy/JGy8PuKo9sw6cNWyIhKb/60J+MIbz6vCJLLquFj+rjg+079vtcRPgpMICnwFSl
2WP/av4Imxhxwa8/4iejaFk0oE4tlFwG08eLOY0T9ClBXz6HxXQtcj25bpQ2PpCMpfhmowZf3FLl
0wsaYFwBExIBco4yz2IrlMO0EsjTG/WkUs2lGWOb4jUTpbOt+2G4s6I53SeiVa85/2WP1Io1v8a+
W7u5QwctcPKYghUeDj8oA81VCB7/avP86W+JWG1BCyI3PR/tIyd4wqYTlMoybr1a2LPLADG2TSa1
28Y0srdfP4af+5x/N5AtI93CAIM9HU2D/KedXYt4sZnGzo/wjF1ZwWjdC6frb4ey006xSkFYDYP4
zmmp9Gb1WBxIXY1XuJyCQxpn7ba3ysFZ/29+KQ6iOhhJkDLnQJmGcqi6RB/5aWXmBzOZnNU8m63b
90Hv2xPVLp3WvFe2wji28lz5Rlai+ebJ+3UHqp101vKL/eJn0xBBNTZbb4gS+jmzB7V/GJQqHel5
iPIDInOxroTdX3LGek2r0KIlNdZfzEKfXRMuBNth4LIsYGcrF5BOeZaGUPjYiBIEMmq/dK6EdZ1M
dp+69PqoQeSBbn2xmHx6XVIGFrYlKgbzfMqlaT5H1ObIOtdM2g2iWICzHbGlNF8ivLWSHK2TtNa/
eO6fXhcU4jLx4fY+f+yliMa4Mwrhy2qmba0kNU2UxyI5BFjDV305KfRQcJ59MRUtt/H8FeCVY1UD
pA3u8YzTMKAA7lQNWwiIzf4+jsd2pXamcf/rQf3JkkIsEN5yXmzokuewAeSmmSGcuWVyKxPfAU+0
w0OA5qINf+Bt7jlNjqrHbkED0dppX+zvPrm1Kg+SvE9dQd13vhVh6zA1qRIxlLLEPCQm6nqbRKcN
m9bWF4WK2q9uvyLrfDKZcVFqMGwUFqv72fhlcQNQ67CMdR0tZ/AqLNgTNfjUCmLPMob+r7+jMJHU
Zd0mpFk+XzbtdgE1m7bw9WySDq3ZNtcR4t9yLWOkjD05E+F6cqzp6tdP9rN7S0GAXR43ViW5+eNS
JrBXGAjuhS91s9hMpZJvhVHJPlZc+0pF0o6bsJmu/xcX1al4LOFFy3b640WrvI3lzGCxNtOoPIw4
y7FZGNJbWFXjBsbPiRzeKf3iTflkh8DOgCGsch9VyP0fLzoFiWVmeiD8MshbKuNadyvI5cyQsTf4
VX/9CT/Zt5OIgcGZUbtECJ1vR4Sq9l0/sAebMCBreM32xjBrtxJtT1dg8fY02N5rkc7N06+v/Cfq
LosifVOyZhfC1pKQ+/FzysXM0j85yI8oHtDUmOpTTc/yBx6NaR1VGkGqWtUYb3YVVGTnKm0/o0St
nH1GTvg9LZzhUKlDEa0QQWEp+PVv99lbxXLNi0Vpk3PF2UMw+kGWmLlZHG20bVhSEfojgTjSSJfd
IOz/KgLw582g4k3dlm0aIRsfb8YU2YpV15xiIvSUriFAHKhUMzexKtS/vgAsNGG0peS0yWTOfLwU
DSatjTCP+QEy9A274IeCt3zDBMNxxmmMS0fNU/+v306icwHkgd4nuOfsRcL/VprovDvfyEvKB0rR
XQ5xMflOgA5FJynu5tfX+2y2AMZnOxqbPJsMqY+f0S7kGStU0fu9HsjbMeoUjPatuMcqqUCrzoOT
WZbpV6WEzwYN+FMCYGBjLnjFj1ft48gZQmwHftEZmmc6NUK0LJZW6AilhVugffEkP5kpNFTEusbz
JETk/HqVzQxMl3rwjSlMj5URN4+Nqk8bSmzp869v6KeXwuUIuY1UNXKRPn40xQJhY4VcyqrzaRdO
JkZFqUMbHpd18UWo5Se3UceNzfpNb3Dh/328VlHq+FOwUvhpHQbrwhzecz1Wt2SsIWBGw/3F2Pzk
o4HchARMRxjmxPkhiZZ7R59YHvyW+cpHA5huUEDoiM/Nr0jjP8lvZ7ugZQtEdBoYMGrLZ3OeGSEy
M+Nx9EUSTVtDg25Qx1J3TWYxhNxBtBxG5eIq7lp531a4b4zWmS/loQu/xSCzX3F/65AQtGbbLxku
lmYEt2HQdCebI+CeoZBsCywu2zBMxVf4sp8YuT/98suRlRKk8edgrFnRyN5EKecbTVsiJgqwaRnq
aBzItiseSzQfbGCnMXzi3NnsyjqGS4KoSHoXWhljGQEc0K5+PSw/Wb7oD9BXU9jmWHS8Pg4VWSqB
pzYMFcUUErKk3F7oTD3UFrRfoCzS7Sw5LSbMUvviTPfZlanUU9amOwHJ6HyGMbqosqJw9BPZ+k5G
hc5efRYnnOeGrwg1ezTbPnaH1um+2GR+MlxpiizZxPTcUHeqHz9yiDesEJUy+tDTI4RoZuoSLqj5
Rk1M3q/v7iezKFzu5TpUxuGfnH1GTWShxko4wnYIFhm/PuQbND2jW3UjMshpbrZWrfZffMBPXv9l
kiG1gj2BrJ5X1CfF6Jq0xABfTRBQZLSzqLrBemznYSyYAUCAVN6vP+if7imjmb2lsXQqKO6dH06Q
CpTKaHcTb1/cnlolKjZqqQ8bRJdf9RA/uxQDFpwxGxj7Txl2VZL1ZmLBy1jkmXucebGb9jaKJOrb
X+xhPrsUJCqNJ2ibBpuKjyOlUKopsU1p8rEMU6/PG73zDEQuEYKmIftirCwr+IfJAcggZUq46pRb
keievYk2Lho0s+AVYoTVJ7TaiYlDrgTU8pcfFXMPZx2V+8f/zj6UEgJHCGtt8rMeXoKOIwx7DAHB
oVPWL7++1J+G/8JNNNkVM2Nz6vjJvvy31o6ZOqAKlvI5ptZ6K7q28lu8lyvRSdOaQvj0KCvZ8FfX
9OWi1NIX5CyHgPP8rAiGHlZWBZESQjf4Gmp8U0xU8CyBjPbXn++T8cGlNLIKlg/HNunj+DBxxSno
Gxc9lCDe1mjp2MOnQzzvWP/szv3n2/h/wvfy6p8Dof3Hf/H3t7KaQIBF4uyv/zjGb03Zlj/Efy3f
9t//7OM3/eOyei9uRfP+Lo4v1fm//PCN/Pw/rr96ES8f/oJZAgfRdffeTDfvLR6fnxfhN13+5f/0
i397//lT7qbq/e+/vZVdIZafFsZl8dsfX9p9//tvMOb/7a4vP/+PL55ecr7vdojF/N5kL8X3P33X
+0sr/v6bIv++hHvR86WpxwSkMx8O78tXjN9J/GAyQgHDoKDNzVeKshHR33/Trd9tyFgyZ9KlhE0R
87e/tWX380vG7xzjgFWxnWFCW4Qm//r0H57T/3tuf4M0dFXGhWj//hs75rMXmwOaSVACJWuq9Py4
s5OQFrchUlEcJqo+R0+p7qRgCxL8kIqesAGQa7n1HI6HjB0RogSFS60MknWV11mwi+Za9qvIkV1d
CduT04rqFt/Ot4o9104EnXKZj6VzSPEuXDjs148hRy2qoailj0VMhG48m/qxdxrfAFe9q0LHxAjR
t/1+jGcbWVBIqUcCd+CqvTIcEFR2my4wKTA3Qqyx4c3Po8XWauyxq+5wkUyHsNeMg5KMt4VTxseR
795oVoNiu+gHNO9t2DwJOBpYl0W7xqV9nRmcLp2xgJcJLMD2pDwKN9gMEz/DXLxKdZIK3QZniNtE
sbGpVQ3QeR5n43UCDMJdFlaP2UlFPIDWWtOTag8eZdhkYaGtMUn3b0MG8aDR9HfgRMj/SzgHJVZr
T02dZG9m+eQOUkblQ2v6I5Wsfq9kJA6DhVSs3dCrVo4/Gyg3vF8SasasjZ7kYpJeaS2IlVI5qYuz
h6lfiaf92OK0dS1llJ7nRkGo2yXWVggNv1Fp1s5zqIh0Dw6vum07jfRKvc8gXabZjxHi0jYt+vUY
UDNvo27a9vgjd1GJcXBVFNpGNHKxtZEh3w8NNKwO0+wx1Gbr0EZGbbhA5/ttiT8SO2GcGQfMqorX
Vc28yzA/n7RYBj5p5uXGKeUERG6yWIa1vIBNSBgqYM6FuTNBGu4M4wcTsnnomw5xclDO13OvG9dq
gVzerHKcNEi0N3YtNRvHadtDP8c4jrTU3KP2B/oMz2ZrDTirQx7qvZpJAxgF+iO0C9RNDYrBw1uR
rAy2cqtak5Q7uA6ZutJhOak0J1zTmAO3Gi2sfTjasQjQcc+rTStS6xXlKv+KBZdbl8krawR9pOb1
emBxRDQXtFi5amsPE0g/ElZheByEIjez4nxlBRkAZZgAu9ye812U12JbOZCczMHZ5H0vP1BJse90
MxDrwVEUyXNkGF6Zmdm+6Mwe0XSiP5VZF6HMJ0HZNUK1OAROESWu3OJy5OiNYUJvE+UpyqJ5MyV9
/4bMe/ICVtUaZpyqrtpqVHZ2a7C4ykUcbRAzB/xhCH8oLNjOALozGBcgpp0JJJiG9t3vyo7/nHiW
vTuZqoLwfqCkbWTjN8zssoczcHwt1Mi4w8zxLZWUBmlspp2Qxx4ybOb4CxVlo0mGcoljJfBbzrWb
AXeYX1agmoqcWySgpR7rmpSJAjns1hydCNAQyJbRbY0ostxqyrqHenDm1A1orCLh7Z4kKob3at8s
yDV9WLcEBsvjWG4LYhBWqtTIWPHTp9JuZX/QreCRV7W7SBI7u86j8cEKHGvbGZLmm+oyGpGVaZej
ntxkMdLwSYzxWorT9CrocMTqqbAhZg1jd0K1r0N0LRPaB0VZpw+mOo5bCBrdpdB6670eI+Uw2eiH
UNe2Gp5fskEQkA/wqEZZXOS6PEr+EErqUe1EjrQ/HNp6hZe2OBHnmWCgyQ2sOGmzKeELuUE3v0pD
Mx0jIgK+YypgT6nDZ9tUVRt5o26O69aWcMtjs3pXAmAzDj9vI6WT2BdZPhzUVOhop6d1laX3qaQb
IOCHpMFCL3X5sLe7uHcu43Ii3UOCsflY86qfSjYviZdIxXxdSsXRDht9pdmhumMpiwJXhTCA2h4x
u59ZenE3lqZe7WSo6JsoSNtqlaijz3oTuXEu7VUrHFZ4x4VLWvrkZjURA0AA1My3Y+kBRbZ5mNM8
uaNlsM6dwb4IB/h3+ALVFRVM7nsZJZvRDFb0DMOW6FYn3Gl61F2EoJKWZEd9g0MBElLav2m1YMXq
knyndSgUFAUs2gjlFsKQkXrohPHMZUQfY1clQx2Co98DiyupBa9pKLyZafOctQCknP7JyrKTLke3
JmpLjF5hArOhMM3YRQuFFTEcq61IqxeYF9NRmsrwwlCWQUIW5Famr+d3mtCQRI2hsq1mZspkbk9U
RLUnKVBCHwFcvsfnjYMXDtFdGlvTN3bXtg90Eo5L2mUe/IsWVNxcPqtZ/eT00ykdnEvMloHb9M13
0dQNEdn0nJkYfWaLgVOqNZ5myrsoseJ+B3X5ICw18ibdvtYyBd2ENLwWgxQ8iraKVlpaxKuwmGeW
bafwyPNLVrHtAGFKI0KMgChj4dJAkYWBGl5mCPlWXQ/mK8ti22279KLDgVV7BgtwCct1yLd67Mi3
VW+lLznHg8SFp215mJWCHYkS9aaNjZHZrsseJ2IL9zAD5o1twhrB7B2QfG2VTx3GfB2Sfwevy8LO
oqiV9soBtVorZhEjlReaRQhsa3wHoK1eOlkuXzdVZAEy4Fe9xDw64T1t96qdTPvBCoOHsh+N5EAp
K7sag+BNGYZs3wQsYiYcgdBSqIfTdNoM41yuKSNiKrQqa+ekMTZCYUTP9RQbIIwqDeClFFa7wgjG
wgdBu7NqVhfmZZs/DGPDwJRXSWmMBwon5mU6yTCIwkyprsNxtl4KNbvqIYT30B1kFONR3hZHHjFm
KAFV92qYp+5BS+XHtuSNGm3KRzF4BBt3AO53IETrsoEorxBKcq8GUrkN696IvIKtpwWITl7AEmwi
3Aohywr1rvlUxThMwkpraP/VwdEEBneKQF/eYKMdd0qb1qtIqmdvym38haUG3hf+qvTG75jpriJz
avby3rZOYR0ohxDv/RpsJbB0XXiq0ag+CJLgYo5MbRNluI1ccHPp6KZOHnkdZpO100Ubqa2Kbdnn
R7g7ikteEV0IEC6lJ/XQAUDyzSZMEh0gksBTgx8oDchF7/RvghJw6qq2NLpFoqQYa01QkupC8iic
6VQG0JdmQnX2Y6M0dwlcPJYQBcZZr9ijNyhyfdXXUiW2GZKm1cjLTjZFYmq1F0Px+IaxJgVNYCuD
p0Ld3IDSD9dWYEu3aTQycWEnJJF9MKuHuUnq54bOtnwBqiF4z7S6U24jIBHwfSprXpeUUgJvjq1v
TdzPGbTCWFfXRUjoTotNZmOYiX2vl+2PRpN+lMLUbgcnsFc2FkyMHZoNsUlU+YujVQKXcZbU8KSF
c2p0q2MHktsPEH0ITeOr0h7d9kaxSUti3S1vdb1tNhZHhnXdp/ONkTBUCFmf+cURZ3eiWcsY52z2
WjSXylwlHMSA9SN44JeGZD7q7CXXWH4AC4RW5M/jmLzb+WytbHJbdt3ESkoNKt0Cc6p8nkS9BYs3
3xcjvbo+/1brqgEFACSpRaGMLUR6UTjsxPIZpz/xFEr+bBVp7FpxfKEb8y2OHdz0hCO8JMI4Jalo
rtosDXfsU64bvV5nZnXC4/Kulg49q+Kmlp13Yndu4lF/01J1IwFd2w7lrF7A6L4b7GGXZdZVwJEa
S5aygzfdUi+DpdLW8E70yNw1IW5gHI0UZS019RqDPf0grzI9AhyRza9jEiyN+AGot+WIBHJ8ZLY3
01grKB/jcoCe2JU50cGWMGDFpPGbxQ72WqUgcke/gbJOJEyYQ+oUXgO0gVIqZ4NXWmq2mkctvw1y
LXFnZ4QZiBRlj8k+9Ae825eOMU2U2Z2mZ5sbB+YBy7JksuqF4UIOHa4H2KPT2slkaRWZTXITdvyT
RefaKNNRHipp2zoJQNVq5rQQZayuORlxOynMpCtrLk3b40g5n/SMQCawdSFHLuiCJIuWp4gel6eR
MnqlL5Znq4phO0ChIKiW8+KmY5czxiMglxZfjYVuhsYVhR+3Bzvga3rGLJxX0TYdAhw3QUIptOAB
GzHzD2uvVh8SoUJfs8PxmAudjIj4CaAwN6ItRmlXTBk7iNzcNEE3emD9ifvC+atcVeCWEZ7aN9ks
ilXRPRXgN1hMuts8nmXf6uZ8a2pBs7ZtmAuhYe2LXAz7SNNgZuAYv45q9SLTayz23Qz+NqwfMSJq
NzWGZhegZLsqIEUczRoWhD7UhWclWb4hCCzcGaoUbErZmf2JLfilFdvqMVJGdV3npr5B3VDDjbDq
6yRneM8qAbvYLAd2FuOxN+JrUCeQEsQg7YZqzo4ByVEgaQsn8WG+5oiz4j6/mcX4vUtKZTt0AMvI
WsSJi1MpYsfdScWFwWsHeaZtDS9GxXFvqQOvbBg6N8o0pI8d+C3VF0Ef6j4R9u1dY5M2wJnK0Zcf
kFsXYazzRxqH13GgFqM3mkXlT40zryKFGUGaFdMLo8U9oRdPIWCjkwLDNQSSJcHFLWK7BRAgEVlg
w8rNM55WkMl73NVQmvqZAyuKktSuiisIFhbHyCS8gmLo0DQq8hvDmMU6auTZqzEZe/kSw9H0yrwC
jMCwgwJSf8dMWj4awsgGV4zMQ25IiUEvY+h8gxFoD2NtK5syMdPbvp7kFUAcYy3mJtsBrU2PcaLf
MRjY/HRikvez1Na531QLYH+U6h1R0rFP6bVkfU54vhHcapfzh758lsiVgnG8zCdh3zbAujtOqa39
tDjdD+1gC+odVXXskE56WL+nO3s2Kvgao/QazNPktXh3fyjCtJ8ouCY7KGPj3X+URl4DsLBVNzYU
PLwxnLcIEMsW+p7ixZb8otjJcPgPcFRzQqEDuo/m9Fu5Jrtnwrl6qhLzlMRd4FmmE7JbiK85diYn
ZVT+kFf8pQLdXZnz//Oa24da3f+shrd5L5fqV3v+o/4/LN9ZFEX/81/1sT9V77z5/S2KKRv/sxS4
1PuWb/ijcGf/btMKo3hHRBo19kU59s/CnaL+vhgcaXjLukUfY5E2/FG4M5TfqZPTvaHoasAKXMIv
/lW4s3/Hq7VYImXK6Cgotb9SuFMJoTur3Kkoh20dzsgi2aeSeFa5oydsS5xo8Zjxwt6WBRSYcQZb
62j3BDu0O/TZy5y1wOXioPSaznoBT1K60kQfuZDZBNUatEnJSVaN/Srr6XVcx34IVimt9Pair0rN
JXTnOJdGcUIWfrDyBK7miLHYLKwTXizZNdpyN4OL13uNBlI7HkBubatIMVjxfAiRGdXmYxOWRwnQ
JvXEo2Pk38xcfiuBW+ii+dFKDigqbS9X1k2k9muA8VH2EDnv5XjonQcxy1sj2IfDHub8BfEQ+IhP
wFUnF6Ktx9bFDaaNg2ux1ow3p3rlt+NcdpRN8F+BMvt5nF8JZ1zJaurbFMHi+gG7+m5KOZx2ay0I
D63RehY1kmS+Zd5WY6DXKWssKqAklUmjmHfUHE5kZrhjnW8l525YNK+qcZk0z3NhQIWXqU2AC+Qg
HwLKG8vjpAP2jzcW/dxoxY4+pHrEvRy6yHUoSWonVezZ/3sChgLVjXcplO4EddbVJAUrRWJiD1/Q
97kKYNfsNmByzNRkq9TjeiJDrTCDqyGaYRmpK7uRj5FewUMAVcg6YBzLNtnM6fiWNMsxq8G7P1Kr
GocLSx4uI/zhHIW3fRy/ps16TF/KKiXMBvD9lAFJl+KVqm5A01wD2to6veRpkKREwhl2yMVOxZB9
HXLZCFhaqu21/qpRHxKOxp0xedVwlYk9GBgqrf166gA+ZZET7aKuvIDaq0KvDD0jaG5CgjQs5Soo
DD+ylgD35io0+9vGTqGoGtOm1QoDzAB/AwTxPIJxpMg6XYelfQBWiGWdo2dhz2tZYB8bZX1dDfJN
S8PWndP0SRun5WhCIWxWfsCc1UFRr9SyP07Jg9zmG7ihbMmRk/WPlWYqO4HHNTHSlcwWkPa2et9i
ntAc0x1y1csnAAfzzoG/YIjiEIPX8vq2vDSnI6LOHwln7dYB+EemCIXtDWYTiBDPOXbAvoNIaucH
Wv2uXhym6Laph1WtCuqbL1OX3YMu2IbQkLOOXHu5v8KwVbmlDbqg82wN+XZL3Ej0PVLmta5kj5zy
b4GM7VSKiP0MPF1rTiLJfT02rlvIb0qV7TD4bwdtOE6l/OZkxnM0KYyDJ2fethIlMhBNTt7s9PKB
MLID0IayLKBq8Tbb6qFXRxkQNxh6Wb/Ccr8lXOGaIIMfUWjwWMQEinpQFMY3PDzVOHVzL14stXlz
GiT8P5+GWBcRXNi4L91RAmplglS3p+Q5otjg2LwekqH9aB35XVGhgcZ2D8NYYYJg1Y7m5ADx2O+a
cJWE+ZXD/oyz5/XYSaApIOx7cyoXa2WAD5+Ez46RkqNap9alNIGTl2gVRCUcQnSt02qyIVyNUXYJ
XqhcKX1zP/EiEQ13lOVsKwMtK4pn5M6xYTxR3UvhqtcBhdtau43FGwhxjk75vDKL2R2r6JWKzimy
wBINfefB4KWfC8vai5eAAznQ58usM8YbJtFhpVjThVLwTkPvg3xaZmTlqAc1s+rbMpIuMAXrO+Z0
fVNP9x0npllX+yugm0+BktduX+q3qaW68G5jXxctlOqsoUobtLcTO0QKfuo19YLLZDTDnZ0N1KLC
at4GDf2BUpFMUqp4J62OxsWQxt/gMhwwWFG8DS7tHn2blF7YpT7dGbn82GTTFcFdh8QyTkrRgtQ5
wAXDJs1JQUTSDbu6BX1qvi+hER6ZAgRLT0m0dSYSVofMTvaNno+r3Biveiqoz5pwiHQwI7gFk8He
inK0cKGc1WuzNlcWyEdXl4KLYJibE0iG0c17EDKVnl1QaYbGI6YFfTcV4iRqPT7GOeioFOkgEQkk
O4AC2sHAoBlVafdWFcIbAnK9s4Vj3sLu7FZWw3HdkGS23UHwJLqiXZvmGD80ohrWxhRRfpmmxCcP
Ir7A2D4eQkSuq7DVy62ZtSWxPlXtg9fCo8DMuqqRwbAOJqlXw+WzGmddzw0PDa61RDkj1CTgZOqb
gW7HVYASul0sp7ehHdR+A6zUDynU7hTYq3QKvlcivFUkaavVUrme1JsWrcpFoENLUSG7+Q1T1VVD
f8A10UkWJ9pEYg0/q3+NJIdIBLhcym4iEMNlK0Kbw1CLkzXY82qY+/qS5gQuB/NOMsZqNybWQhPp
cGKGPyjc+1Rrv+kFqJjIVqkJa/k+rQSHOnvFTSYPQq8DdxohTgur0H2Tw9UKRuKzGCnKR4kNTsOJ
HsHZwDvXLih2djsdTF1MiscR9GX6BlhacitpSPZBOtsUFwzkOclI4ohCkRe7K4HrcaZshro019x3
NgImLSlINBA8FQasWZPoULZXhi6hOioIztShlPpGlYs1xEd+mtYhx2QZuywK9UVTsnFjVESDtFG0
zWvO/5p6SW9/8ECB1xedzNbAesD7S2JsOEEqTkZK2uX0qiYAJadwjIGyDAG1RnvapuasbzulI5Wg
Pk7ofWf2SfOPUACVc5beQWY2jyCsvvdmeE3Gi0xCSc4UoGZHZUruaZzu2pCiPFEFs2StNa1Asdzd
qU2+UuDkUPx6G630G/o5Jotq03DbQTZtKFtsTJve17gO9ItxNFcKHRenNPYxwRJOyuEMi0CiUFaE
7jq00X7Obbp3TbfJAMbXU30sjXTvjPll6EDJHC7r1tgWhXQqq2qDedSXQA+6AVu1Vld8KeXV0BWK
KqHJ1gHhb+LssfVbzyWchwPHOhitTsT4x6ygXGaSRMEJ0+ns5hadX/DgjuzNsh7sUDTbmzRUx3UD
9Rk2WylpFJn0IvZFPRP9Og9wOfW5BSCltb2xDS2YC1JcxolnNIhhqJ9aB/bH5msqLQlD+Evo8Zmp
F4VCRng0R9emYrEkRirZrfAMpZU0B/LGDDNnreaEm/a9MHytVenKkWftFU49H3qIszdK5CQbgleM
bRelykWPO+DbFM/1TYliwY+kJcKcuLHgVi+Gkk6JCejJlhNN9whv6i/Rh6e7GjzYlmCO+rHRQbno
g4b0Su7jnrCdothWcjXdJfOkHBvH6PYUQI0fNK5KrxSDuHZk6cUYChbTrE7EyYaN445hyUYmr2Xp
lAALWnfgr+/kbpB3i7WGVrpsXVOgAULVhwbUd6vawp2u/VLqG28OVMHMF2nIBmmKDcqQc+Am6syz
UMesmT80batV2nbMTKqpTvyktrB714qQjUclU2Nv7pVohSY3uXJMwpNY+1tqVWYEHgUkdnBv9p2z
A+s681BpIOBcZX8yFVRt8lY6FBTE3Jngg0ctyYOnXGuzvaYNQ+GRd8sesZqsl5mcIyhJCiAx3Wq7
zWDl3XEspOSpcTJ7B0WHWqQ6kKbsQrbqv89ZpVM9lHRPiqCImkJmQtSklSV1+lEt7ZvYMTbGuOBi
w3jVmPa6blSS4aV9HfYQn0hr3nAnJVcLpWNQlCfQPQ96Oq6GaTipI7pSIJfjeGDD3q6Qy80eaS+z
26XBN432IOgpslfS4iKWCS+IWAEnO9vJXXlnD/k9eXfrRFQsSiPTE8BHKhwgdqjy92IFNCDzjTB5
ljp4AaakrMfYqnxwPbM/JO2V2mUoPQmMoGCBwIb5EhhzcMzUksCJaOe0gLvpzSLgrHzHDB9KauRV
TmJqDceR4wzahTKK9gkcFOD36BuFBKsoD/VH6Hiqjz2bmw/XOFXtV2ckV7kzYDSawJj3yaRXd/TI
COAa/y91Z7LkNrZl2S9CGvpmSoA96aT3Lp/AvAVw0QMX7dfnQlQ+K6X0SrI3rGFYhIIiiNucc/Ze
ezYf5ixBCkCwIGNlij5TaPqmFGjcYfE8klnp3aUpTW+Aza4vM/uQk4/TYevbQMsqLzWAXiiEvPhu
RLgWmSfVGnD0IXJMtBLe3aS9lglc2Er6IIi2oQrKTI5rJ2fiRi7PYCrrKpIn3eEhCS6UYPCRao7b
cVqa99Z3MSXr2lsCMmmEijhQG3GuFyVnXX+ixvrsWubhLlftAB0+GR4Jr75mqQr9VJk0fGMeAMXA
kB7VueuRfZRRoDppF3TcRzk3lPxYyIiOlQ6ksO0OhdpdSYnVlom2u808qNZJG28rpQkseN9B+w/+
GDDbiN4M1NKKIM5iw2nhnNPeggOoR8nOSgzjWW3YIsjhAFGlpa29MXPVuslkYa/zNqsvsYHgHkBT
EuSQpY5tp7MoAGDmG9x/kL7VzIQ+TkShkmTF46go3pr8xPia6UwiZWw4z0ui7tZWyXVYaOGIXefR
e67daL7avd0/CnvK7h2r03eq1csNCG6GyjA7rGfdktkZqLg4Z4Xi3RcQS4g2zUx91TIvoa4Z6r2m
JvnzUE3NQ4Qz8m10Mvnec984SPCEB9UGN7Lpak0+evRaL11aiIMSu9mrHaUjUPy077dm0fTTyvJy
78YbbPkiLeylmFyjO61LOJiYYnHf1cMkf+iMyXil37UA0W1CLlajXocBJPtx12G9x59VOA9WU+sb
t0jHm9Sq1OOsJdRiDi+q7eTafajXSlAmjXIuzGjakwtX34TkXum+aVds/QLeHISWubZPHALzEXoX
5ZtrNcWzTDk3NXrrfq825r3nWfELltCG3LJ4ap9h9WG5MOcRjBZ0YcYDwly7wM3XiiX2s1SS/Rgl
jVyRnKzfkbuD4KDgkgv+a0p5ND0HtcsMWXeT+CkT0ANriINXT+/j787skQm1kZkiUihJo12FThxu
Z7S7vh7q2mbuHEpER6mmY+qRgLTyUvfQEktB1suSPdYaYB6KU8xbm3jM50YCHBDUAMFsg3SkLWFK
+yFXmivnbrsaem4LoMwYDZr3ah5TxwA2yEIqGgRAOZoDBVYN6W+fHiTMldGQuJIaiU+wQP41dYm8
6TOxT0KEGAWV+rqzNPj3irtOPVQTZHdtdSdGi2KuIUNQd6fJrUCwDhxu4BqW/igIQaBG11+aPL8h
RZcQQpJ2H1yzIQHJWiD5RdNxj2ASUBUzWhC4dnn8PdMtwX7PLEF97uJw73UZ8gyNjmzbkxKhzwdX
DUOw2cZhLGoCQwZirPJsOJV6tulT4LYeVZgBKpGqdKkjb11nSbqfh35nh50Ho/XWnh+FNQP/p+1A
R8mFWFt28YOaSLoERlkG3Fj3qlPurKbRVh0oR6o+rTrr1ZfUL3PJzcsC5U1mD1U23WwtJc84HlVm
lgMtDaeuVrYbeN4xqTdoazLWEOOXVo2+hFZsRO58VWOSPRa5cm7HgQFLzSzXw2a603QC2Sbo6cBi
qwuV1Z5H+cngGhlAFxIj2spNGo1vtm5f2eTY8+Wc820/J/TfavUSKjO0V/omIuwHH3NptJL1UqQx
/mRDSK2tPav89Ykv4qBSniQSujavKUy96tg1c3eEcKpt6jjetqHtrRtmNAHiiz6AXo2oCECf2kQk
LJ1w6UdC/Kht7YLn+0PB/RIkHWdohLQEMBLzyxwzx5ZTyF01YKvXTZl3mzimm1JPlbHOy7wm7wYl
U66X7W30j4Ggddla4Etr7UNajicox9wy0/KpieoALuwbbLrel0WRbMmAOPfpzuuc+04yAtbT+aw1
sAmBL8XCO0ehasDAkumuFjVjorC11q1R0XfxpncGF6fOC+0b9uxhHRXt0WQwC9GZuWLh6QJ5I1ET
VnxSaQit7cgUbwAseAntunyey/FbG6S1wUlEnnSTiXXk6jfIaA4e5GSaGm8kuagnM7JPXavATMPA
cOkK2zuPgzFe0rZBTVBWAbkMx7IK1wQE65xK1rdqL5kDjne2eQ9WjnPvNVX5ZAyzg9+SVu6gkPYH
mZTBUi+alRpXLja90ToptJ7u0YITvFUjJJKtvGnSeWsz68kLrvhGrz9N1N7revZuDD1aRuYA0WnN
tCmFQLHJ+5S3JXpMSyPbemRxHEH4c4Ev4j1JACS98pY28XjVstx6yOkzJq6hbKJ8nsGGxs62xIqx
0Qm32wpQ9yvu9e4tcKoPonKu+mwe+Js8cSaelTZiybtvcMxpcE06W6FYzGhRsrcSkvY0M/FHAoTW
8LOudejRZ7TAbLppstVDZIx2IWtGcO7RW2iNxTi9clgRzeol656WEIIT1GKejoZwYLB97ROtunA1
OGuyPdrLuugH0wjcAQ6+pziHNoy+tD5O1wBmP2wLXD7ATPd+zJBfdGl5Sx+NTZJIug1KuPLWTmuA
91nZEeGg9e6mTWeddK/KOk2oFi4lwWa7Fh7mJhkYCKpTUfo1Sk4Ormtmh9WSIPBkdOl2mFwZ6E5V
XTl4tgVT7J02u9ZFWkm8KtiDHUtcNDu/dyHYkjX5iSDqn1OJX4TZYcArilaJq01QiPrRcsZ0F5ns
qJPcYOBZ5eSyya5+MuxXdAbWJRpV4xJ3pBuUgaPf9nG2ztQ3hX7cvVtaS8Hj1getmZsVlZh5T2JW
ukVF1D+QLUYGjDt2F1EYylorickIZ5VEMtwSiXB/EGDKRTFpnuCPrmi0s/F2hEisjCGLVplX+RWJ
gHzTsToJdSQQlEQ9Jq1xemQSFhTqpdet8QDplHBUHKiu06/1ntjTpl6rTITXacyCQJLhceWdMi4q
dGe7ep964V7VlPNA3FTPzKJCz6ETRAbmw+8bfVc3ilhbqBbFTIFM//UZvX17jtGioo1zLL9FoAGk
uWfEDG5cYG8Jie/1IVb5Ro6AkiZJhXKsfUmh06+susTmVLZdEBKotytILqSDwLWrlG175ri0Vm4/
cQ6K6hu9TABkul4nrhozKpnFxl5ox3S7FetAbg0zCctRN6T3fuiRc0zr4kTLztinXfrSTJF67Du7
OaTpsM/zqNoJNXdWxMKhJoSWS0oMIOSha7UvF6/1dtC7U7Y8diVnlRhtfSDbV64JH1z32Nn0vnn3
tJAEAsaboV9YA3H3vORJ6BwY1IDfdM0+MED1H3Kt/eiQvz2I0P6KC4upr3noaCUPcaFs+i7mRIq8
we8QjfCOQnElQjRv32vXegMj7fmp1xsPlTs88Bpcu9xOgsqIvrj96CdiAA/GYFvH0VJQYC8ptBGt
YDD2xE0YVcSVI1yrWQq1WJiruFOGPaKkAm4sBSUs4HMqxitVw8WOomcYurQgzHxrzcTR1kI/5Av/
v6m5C2R5fNLFcED/SGKKziDV5Wq7ovOJyE8YbFUW016BymLwVoY4x93ByXdO+lCkZ1k1F8rWAGbC
Jpwcm7PfxmNXEwaFvbzA672qF8UhIIEVPcSNWzVn1H+X3tRuO4X+ZtzAnCbIi8uNdzEcm6AKcMMI
NL4UYpxyXvySJBSG0Tn41qSF3S+voxT3FjnOe6sbLlpTH5qhnHxTn266lMFRrX6GdsJOnyzS8kSS
EMN/QJQfXObUlkQ6WKRxZMZEgOKr2qjfXLV3BOwVzIq6jTK5914tTpRVF9T2n4WZGKfFwY92Ka/W
wMqGy6REx2aiokOm9Cwj2L5uVXJw3+RKduuhCaJ16C9pj4ox7Qqy54MZRx3628PgtV7A4098bSjQ
00y3vateKs68QX2sHRZmEfukUWzztHWRm0XrvGnv+VlRWjJRCnsuSW3oXadl6FgtEYoaK444qgvg
vyPRvYHDrxlFNMgKcqBREcWfehydtYIqGBvuIvkt95HlPUNHKFCO0vls1MCNrvbSpNeU586Cca1O
4tKXYg5cg8WPvGK+JBpLajDKkJxNx9rTY3nx6vK27Pku4+jti46pVLStZxwI8aiQwub9MPhfdrzT
g0HIvOw++5jzuVaDxkKTdON5+SayCb1w9HMd1r5NRkhG1Vhhkc20H5mujQQGvg9x+BpxttnVAJNu
jTP/YWrOdqGczbE7MBr2yTHfdb1zQRB5LEO35igWgitg4udIxdcNvbd7u2Thm6XuBnFd046zyfch
p/veY8b7ULejdV85RLspRqQ9GOWA4au1ohDZHzyjI8XyAWY6CUpemCMCpb6bTGsIcFLfCuoPOtYm
bI4aP6U2K/uoVKJdrblfXsHWSOxCi5JpzgLk+AveGtq4qBvfBs3tYz1e9ZVw/WIpgqquyPY1oHGv
7y6QlrhRqZPHPXCJ5SuV27RrDtg+bsER0183L7FCVEYT5+iSVYRZnjyCUYsPnqkMm9GNntMqvoDX
2GsRAQQVsS+IpCyIMDSWfHj/Pc9nPCJRcx5FWX+rKi1WAqzdFdKKmEu5d++wAwYJ/JOgLTJzqxhm
dVR0uRMm9NJ+vsvxuLhUKrd9CycpxunfrzyF71QlXKZ0TzlVcbvJU3mZa3KsJuSkybyV04cM64tq
3RVluOvy3rfyjDquYSaclRudtGYTmZrbVCtdetRzn6jyNlzrdxJxoY9+KdkniMrI89sSf7lJaL/V
Uc2c2954wuCW0ZCniNTFOgmNxKjyKIsqiM0HO20vpJecIsKZiZIMRuAUjjHgAkHd+8MzCuTFbWr6
skv1JxCtkW/YEbXMMGDY8KEq9SSb6pvEfoijyU+bJ3gem9BKb0hF30TNXvRBNp4gs2/N6MOjDO8m
y6+5DSgTjKBGR97/rVfLaTvyrby1lSLhkuPGkB8xHmWjeslE8xZOylUdFpmBEUR97M8xHaEUVY48
IVby1eStiOGpU24KtuFaEi8JKoV8r5ymTGb/QJnDdtEnARd6nzvgAXRTUKGgC2orCR/whYLO0ejk
pSYZ5naXqfvZpdQm38RW7wRgMdQ8bX0tchqE1Vz3+7YhgAxVBxgYo0neVS80t0XHGw2+zkAF0YLG
YlZPPFFNa4E5ZKK6x9QNzUVNwFed4ulcVV17CIks3sreqtZlXphPRaJTvI0tW73Q6S+SKJmux7gi
+aTQflgo6HyrmiSN3Cz6bk0UZWrKFi1MtXzuCE4goFmNx3Uj3OpuzAiqmDNxySLNXaWJyFlrRKYd
UP8Qrqq315TrwMPIpd6PCJQztJbBnvVSe+HOgTlNZOKjQ+QnI//sRziR6FGqTMEyNtFS725b1XQ5
rJ6YnJfbcjLLFdFu4QoSNyo9xQfYRV4Yr/MBC3tNoGr2oQv7yvDuSe/NvR7H3wNKeYk+fCWbjDbh
ovuz76TrHryQPm81ApFw6O2SBnRRE1ZL63nRumISVoUv7PKEgJewLSojyKlf8GbRtQ4HUtRVVgs4
fnwLB1Mvicoy5O00jMuwNL82g9zNnnGDLv4Caf9V0a07Y1AOwpAnoty2woKQp7dDyk85Kzv4Vtes
tB3uhdH9qIpDbsgX+AET9lfw+JK8ll2VoVceiXPzzPi+Ho1rrsaBq9ClLg0D7irzx46xjZaew7BU
6RJ271b63WidgnFn4o3SWrQktHyNdCQzoHO+ZUw/Kxw42iKySB2tCrDcZf6S9mWAliYdMr5BE3rr
SqJhwjncGmP62hGPvqqi6qsL43dDJYkgtpNDM+rF1iiUHQk8cjXEI74VbDKIYJ05OngkxHKRLJls
R0cRek9cDG8MDYaVaJIrQRbcNyfcCe6KJNURl0V+EgbHaWm4rL4mokew7MlaHpAkQd7mNK2IBMSi
RWwxjO/0pZqdrRtjNjPHZcCI5anwArWssm1lUbKE8nWq8osIW85+N75XY1uBW+8ypwzvOqwieKZe
ySzamxLfSyE2Eb2KMK6+dVNRN5HuPSQlIgqyuKTirBuM4IHZ1VuXtJodWvcJBfJorGcB0jUGB7Qi
Fe5m5KYoc+NKANzeFugUKSbftDgniM9WXjXCnWgzat9Cmzy/EO6BKfgidu6u8ahdQgR1uhpdFJI6
7Va+6Ep7KQiCBuFz53jvXrdJMvWG8SG6PpmuLdsg0MjzgmywfEntQ2D9LhPJl8V4VCtXtcaaVHsC
DMmeV7RzxsDaJH/czfW9oLk2atnd1N27zn4CXuEW+e2Y3+upEkhpL3oAK2JsZjU+RSplG/GDCP6O
9eSk63hAMg0VnzlMkRyduc3WtRZeBM5U5n50rfBVM1aisqWjzOVWlcTyVrWzJcu+wRdC5e6Rba8K
InHJ8PlU5vyEDOTe6hLIlRqRoF1vYB9KbmULI1sR4HZG+uY9Z5pPHNNLVk0HTDufUSMPtqfdMWoL
HOFiztQPlKvTysBNFlNf4hkksRQHl7M16ilwinI7Vda281osCaLRkHZ2+nZhg64ShWx5xg6LeAW1
Ql32p85VP03REbZtPNZV/h46kIG9/qvLCLNCbKt2YRTYyAp8vWs+pCtuFYtkW87WO5e0nLi390k1
oLXCOypaxlLkDXaCCd+3qsh+bTpfEEEfmzHF0U8G9qDl+k2T1Scp5SUe8KWRNoSiwct93JnchOby
WMa0IMuRBGuM+i9ccvdq3bxhqXsZMOhvqRyP46A9TX39XTDYXek08Gh/Kw8qS1ujAbWdp6/ZQleK
I+l7iHTX71z7jfZxjSwJV1gS11fOYrwn05UoKJ8LxnZRaTiZtmHIPwSEJ5J61qXEevCLWpN+EkV+
oWXn+ARMlitym08KKlX+SSFdTZu+k445VsNNVQ5uF2Qqk9oMf1WkRKemrfBm0jFbtbokoLoFWA6s
mN7FpOzdukddjlKGV3k8JFFe+r1J5xaBirapbO8Cx1I9hWkc+zyj/JH0Db/UlfdZSpRR8QOx1gR9
4N5zcMmvjdSNj0k88fgqpmRkIJW8j9qxYPDgNzVJcLIhwzhkrXI8KNsKjc+2sXvTD/Xk2xLe/WRi
o8uETt8u33pR/yrtLnDNU1GRNDI1POhYJIHTN69FM55M6oR4U5lTuDIrJBq29eTJJGBoatHlaPv1
1CvJairiN6URj9ZoxkfCmfUg1TPr3VDU7yVPa4i1t2Ggzsqr6oeeiFMyjcSq69EylXqXrf6jRAZp
MUnFjOArrAVURSSb9i+zh2xiICsKB2R+CscaYUOyN139ys91xH5WLiOlq8jMoFJ5m3RmEhkaiIxA
+Sm+dO3ZI8JLPiWOMANp23uhV4cIoEZd93dulmGVq5YwYC18sKSNWKJDFDNpyBq94WAb44slavtG
HXUnYKJ7P1fTKvLyozb2NzJxHmqdR2joGyduNiYdsdWQA2yXuH6UyPgRlreNguit8uaNYhASUnfM
s/L4jqSvDS05bBHerYayUUbjM7nSr8jh8fcO4r5V0o8e5WHofBlcG1qGvoNlMP+wDrrcKhAz0v1k
VagXmMKm2XlZFqLc4Db1I/HY6R1+n7uEfgBwHzOYGupalSFHhQGCjgj4vM040TOSeaIfCqtDW07c
UOwgDXPV9WPs+drFWibueUHL+baO7ZiUIPIFGpUviihVPeiTTL6ctJh3mKCUL8xE6TqL++J+Rgf5
bcQuJ4yONZwE6O98SOKbJLcGkoMszWT0OslnPNfDDYLafFu46oTCoBPHSZHufpprY+OSgX7CIhCf
SOaO38OCsL1YoW7FdIBEnJnmJg/VZqc4rrUamJG+DHb0FnpoWyzx5tTMknRZtsxaJIMexdHX6AKr
Ux/PzTkTcXrjGLmK76p/agseoxrSBV0bSvHkVOkSOqd3Bu5vN2KgmX42UeOz54KKUDazZgZjZwdx
oV3KNn4GXomYzX5qEzSmWlLUSxF1dQosvjCjGBgwbH+oha3cEvb8YRtvJRcLv0rwiXXqWVTpFQj+
KurCnUIDYkcfSVl88vm6Nmdjl/TyWifOHUK25A4DVAArBP0UnoJDg2Y6WEzo2EK6G9LBXpJEHkv9
Q3QqbjUqECYzkumzZD4PuzydotXIjCpUkxdXPWMXWPXDSYPgDDF6FdnX0ul3DMnJXCdVUPtSBmaL
sbITHWF7Rv1qiPeZiC2RPLFuie2mxjSj+VVJ+mnTKXT7olZBMdIiqXGn+c1wwqPEeLGy7NL2Qwbu
3BadAwFRazolN6SB78HyIWmKEA7qyTMIXblULzW7CgFW5DOZI9cmUSDPUq6lS8XAxqcnganvSX24
1o7Zb9ykWxuZGr5gps03RsnFWkH0OGRxgIXwGbxMXyXHMplwi9BMGkWBoU2BUDC1HhXuiCu26e+z
zjuFvUtusPSKgISgca/PIsJP2/xocudNhrSA9SZ9D2HVPdEbjDfGTI64U8Wp7w3qhownJgEo2ZYU
4VVvGk7gOe6avF9uLeCG/drlcM1G2yHmmCBRKz5H6bzpR+2ZLKljK5HpFtY2mSIEy8L79HQ2SRos
yg8AApo/xTj8hV3TnFfmo1IORDVP21QB0YAvGkeZIO7NbokwK+YxXDle+BnrzAAlklfF6891F58c
+ZW0KlKdhfBlWhPcgDF749Bl8Qzo4crxpZhLYhpRu7oc6gzLYbJ6ZbUivSCA1v7hiI+GFKUVzb7z
4FABdPyDhXh0ZXHNzqpG+iRp0nPF08tWMrjrxKjiG7R1K3Znj1mEQ2+0KyHIRA+TjMo1lHHnK2+q
IlDpuAWRVh0QAJybRH1ixo1v0cwGxNcYldcpTmD+Fgxq/7EZ/Ed2jP/fSCge/of/t5Vi+9Xkb8X0
s5Vi+QP/Y6Ww/kvFOUMaD2NMywYB/C8rBTATG+Yc/CmDlg1SDv7Mv6wU/KEFekpCAB4M/R+U0r+s
FM5/wVmG2QmRHqg5avv/xErxKwdIU3VITdyScI8CifuVEDw7YV4Zck581KORg7jQLigrJGRBvNDm
aNHA86zxQxuL9i+Enl8hY3wyT0UH9QJbaUlfweHxE4HIGdpUKBExe22b56ygWFXfa1uGzjoyqqlD
s2l7ct+5Mv1q8y4v/8Ja0haHyM9QJ001iN3lfgO22gZK9IuDRJpt1Va2KH24WVSFMwvG8Jmj0DVo
R+9RTlr2Rau64ExJZxxNcMnKraS9sP3pVfkfKs3PFBp+/l//HnAAwdyQ1GSCfvrlOVRDhZpVaQVy
Q1LaHtxwop+chkI5S0PnOfQ4qq9//shf4Uh8dXyyMFEZl+HbNZaf5qdH36tlVqPopZoWs3VUjTR+
oWwfDiQXc6/882f9/oLxWToOGQwSGhwy3vGfPwsBwCg7/AW+nDMSTys6uPhuJLfulUxQRzVjolY3
FILq+58/+N99SRh26oICXbj/y7//6Uu2he1MeoVxWim4vtzYWF3FwRgVMgtxqv4NbPtvvibrmPWj
OeCOvF9jhKpOGlBmDexDI5OgXpDPGPUaTttIfOYIQPfEgVvHP3/D5dH98gZ7kHvBIi8OKPM31Pus
djZm7JwzwFLfLa3kxxPsF3/5mN8XKsRKi6QSl0gdWHK/vi1TkndjSi8szUDbtHn7KUzOuc08Fkze
YcsowPI4bwaIOX/+gr//hKbqsHf+QypDt/cLow/0IlTfChHWQKuWiL+UsURIP/NzpkD9W57AbwhI
TeWHY4fGusbeSxTG/35hHEVLi1rXqRSFKZ6cPqetnGtqt6UR0bVIAW2ENPQDl9kA12/ARRTbLrlR
AE1q1K5UWnFBO/g/fQYOkEJXhaqhcoD8Qxr+6TVOXTUqmYqXfhejfT2qIWFRhfTS4ZyAZP3LXvT7
A+fAIWWIjYGkE/PXD5snLNTk0bMnVoN1lLWabK3IiJmxmEP1489f7Pe3dzncwAu57AwQCr3//bht
djvBi1T6Q9J5W0MMvL2UqtHf+Ie/v76Oxi5P/arxq6rWLxuQDLURPhg1ejPA4EIUm23nYbCCbK65
nkL8iz5UQo4f8pCkSP/P3/H3vZ3sFj4SBDQbrWn9sgfJoo0k1gF6GWQrvtfE8eClmVGL+FB39PTc
VTpHz58/8988VweGOEJ/giF/XzSMsyK7CG1kQvo8XpU5y57Yed3gz5/y236H/fP/YMPZG8gzXf79
T6/l/3X1Fo2mXF0TwW9Yu+YhXRy9I0Hb9xqL9y9xBr9lTQB7J6AGF/6yUPnU5Xn/9Kllo/SK0Y/0
2TIv9o6hEbm7LB8rxA7x7O6UbJ6iLYiWbCB5oFt6JAjEP5MiL0jv7mdvL1CVYOOGSDv/5af+Dfm9
/NA22SfwRnTgvr/eZ4wy9SR9mYmpdVVuXUQ6/VbYVhTTO+sR7haOOMqxiK9hHpE2J+Zi3yJ+ZxnP
6VfieMgkrREtxtqFsfa3df3bIiAUwVW58ejLHmebvzy4fiHKCSPHdqkJ95ns1fx1Jj7SXqOsTW5n
LLPqOcmUJZ0EciPq3ZkG/XqadQclVWU8W+S87vTO6amyIgTZDiONYW023ZI9nDXjFFRzxZacUl8u
c56uBzngDaZY8TPaYzBVRfpZNhw0fq+n/byZRlcOm6HI6UhXFJJLp2siP0BFzXMe7NH96nOtGHfI
9BggjtBrhk2lu/x3+gQxcK2raXaI4Aklm2hZW40qIsYM8chfwuvkHVCU5KoaIYLmPEnjlcq848Mh
VdRXh4FmqjtCukMhbvB/pH07XklOB4MVj4Z71CNzCfetem5f6A/d9IdA0H2TqMYo139eRr/+Luzq
3OMpTGHUL2kGv5w5QA3GmHkcVpGbrN+Q7GzgIglK+2+4VCqGX/YFSNr8/3FSE85jLAkOv+yDYuwa
6dHTWOlmYtM51BWPwORxwrevq4tvcW7oa/SFRlivKoi8FtK4hklDCrQa9u2qlY1xssfIukHyS/0Y
2V58ndt5k6XxyRh1WOewHilgB2H6nGnhHcLKuQ4MFl68jvNZ+nORI6vFW4rcIZybzSCT1xlFlLLK
Z/RjAJhsqGjgW5OxUt+GdtqVYy1e1CaNmpVLP+M+MXugeVy13JXL01yQA4wo2kmbRWDX9e2yJSab
ukT3xCS4utaz7vanJEmFX7k09LdCquG4gru7uD66EM9gSucgLkwmvWRvM2zNknRQ1+HgOrcDiP5z
yriB0YZqb7pYURtCfJS6YpBf2duY5KYNat6mXGmdNj8bzLsrszLmN350zTdbwheCOqZhxESe0IlV
y8nDUCbL+wdVw6ZAMHbrtxXasE5O4lbr6T1DQyrmaa3V8FB23uwiUQcmFQhSMG9DdaruatNJ73U9
zr/MtmvzlQfrAWUDtCvNjyox4sSNLp1X1cbiu2I2r7at991UyD9Zaor1EvZ0kvwSTV4EGWd0mAAt
7pjGGburmoT1rWb12d7mPTkVdWgdFGls7Ib5fWOMxpGHr96AbW38ihDCbeLSk/AVzZINStPalDt4
5F9xOL0qYMApJbvBewGUJ+5QiGHy7TqUTGWCEzUbNOOHVGuIIB4pRTjgnqxi0K8Ngm9svvqnJqJi
LYA4IW6fFUBF5UTfy2sykJuR6ejnKbfFMc8t667yNLojcxcB2CFVIqVvaTXf4+RA5C8VLsVb+Eha
ekOL+sOJ7ftEMMXpGn2Ytv2YzwaYsQxyEd7jp2pIi2gbRrq+qUSl3uoCEZJQrZH2cgVEM5k/mqHn
Pmah0YSDPeMZMbo7JyMZCtpjvSXlaSa5PR5LdCwoRvBbsZrYtUCbpB1PUCiKvW4VRR6IQJb5ukC5
HvpJ0jgPWiQeYj3ExkHRku3TBhcUeqWk3epeZYn1LKfsuR3lzJNMrYwdI4o4RhR4ACPCzWs+K+o2
G0H8dJo5n6POHvGaANaZm+RHb+CbKUVzHxoZMDp0tnVnbGJ1fmqE9SSoUpGmM55rFCABxOghTHer
1cDGtdLJSQ5sBZZLVneatZ57z/rUhTfXkBellgX41sdLVbao+Wc0F6tx0dojwZrXwEIBBKRAtXsz
Mm9pwCkXvYmpnEFdA1YzfDBej4VlaXvHi+6rWta33VQnn8zA8n1RZich2wcvsZiX5dhrG+utGuc3
pPALowU5ziu3nU+PFHV/VPr3ZqzNF6haDu+zacJEQkva9/ndiIIVTF1xVGtTeRbhfLFGZ/DTKPmh
zZ9NkTy6kfeJXWb0Z8QIkxqd2aQQZnU9aK4WvZSGRtuui/XYmj/g0vQoqPULxILEl1a1EcX8aDgS
JRRSncgez0UEI1Czy8dI0QyGXek3IpOgcnUc3NW7GiePnjVYK3tp1eYdQtMW4Ttxpoiq0mr64H53
Nxrzg4uocqO09D90TUHYVFWIBgss06KNThXvGBHESFa0uxrvDR7tvj6hKVw1WiXhxo62jx0wAqGk
XXDT8gvNPe5DEZ24fmb0DUvaPJWtB0gHlBtoRehX8wGbD3k/fIJqHUab4DLdBR+b5yXyxYJBeGSU
N4XmCTRiITAbo2KCLY2dUqQK+l7xEA32lqvOzAXBqtcj6wQrrLrKquheN1hDoB8WPJzvyQE+pp58
uXFs7rm9MX7GGYO7g1HwZ8rFo1qJXBk/JYzOF0tqxSFknZ2Q0MFKL6CaVgl/9VHxdkrVozxHbd8r
+nhvKnRGtbx4VCdsnox11423FBkR/jDdwp1YzXtuE+e5RXjq1ZBPZsQM2eL2yPT82P83eeexHDmy
LulXmRfAsYAIBLBNrUhmUlWxNjCKKmgV0Hj6+dDnjt2umrE+dtez6U13M8kEEIjw3/1zs/lepMGp
0Vmwj0dMugbjTeyB5RplBYSiHHH86DjaVr3X3Gcqe1GwlfO1YwouTM6Map7x+TZU0bfmzpDhjflY
skKlGFeZHG5YpD5DdyIY48Thxajx8lZG9NmQuNr0FitiUZC6B4aFNdNo5AZDNGp0VX1akT7VEbkZ
WljR1rPiF4aOhdaWx784HkZ4QAMBO6yMvtpgLs46k/mOirTsySEp9TIHNRfFAjrfV8ZMoqJgstoR
lUzDdAdlYM+ueV8NFl4W1/pp5T6hJpOTf9dMSzC98I66mh4jEzPQ0D/lRXVpu+oRATn5Po71LQ7J
xxkAA9ZW5X2aE65IKIX2ccZShbhECt2Ng3Rl1nobZCPDpTYG15i4j5rBoJBAcP1h3Lv0HzvleGfX
NcH2ynkpUw4XHg5grw6vSRqdakNe5rG/WREexa7r7y0nvU9V9YyRmB0neglwrv5XObclE9vpEoVk
G3RRXHqrWyZXC3dpmZI2PqNFRon2ObYhF0hrOKdl464gxeGgInQDhHBf51gT2GWoY9CMN7vg7t+Z
fJGrbLngefumwr4BhovrjgWnXmE8T+9FODCGEi5AwaJ48XFDc7Ihi4wDi9mhVXYbjQrHvTg7HTa/
6b5uplMLrGprd/4bCzhslXj+EQAraVa4AquVDVkfXGF4gVctcFRCIWPauwZ7290GgoxrpIt8NaXZ
tIog3jC2xBSpiXRtohKDQBEkO4KypDbTfcRs3nYm/ps2fkwtfBWVHMRaw+AbDF+t07n4ErFBBJdZ
6c6DZuA5dAXkDvPAprcfCvbRa6x2z25RX9wsQZSx3BI/VvUeDua5x+zxgMmmO8jQwSaBb3tjTMa3
vnLjO4DPCjJycF+S8N6aCAxZnh5F9hyo8IBRhzxAtXVq8xyL6E5FyVZ4mrdxUXTrITDEqk7rctMG
9rbHSBH30aerYtwlfLeROz9LQU5ymh3Q0VIT/chJzNQ5WpWmMXXDWJQM+ezuqyhmnks0UWrrShJx
JcVTLZ1gN9a4f23jNeDUNiTd2rScKzuNnfCh/zpptUHR+IJCcgJkcJ6Fscfaw/irw7PbSAIj6bTr
lXdFVX4RefCVFM4O4NcW5WjrYFApS/U0yPxhbrB4zPTYKA1wwR5eSi9m6eYN25Tm1ukdB7CpTne2
B7OTg8tu7PpySyX5ABQgc9HA4oAdJ5eDou8NxtjmPgHBkbQAFYuI9d0OhoM/chfEsKsj2TNAH/RT
XTdbbRjVzkNPW8kF1egZ5SstFID3RuiOhnjEtH/v5MhN7miczbIFBC5SnDKTTY65d3BAZOHZcOJi
X8qZL6g1inyFeeBHjNqzDVIgO7wK4E3603WakvPsFZfUZXLfF+Wnoht7rYYkuZQeO3J209+8vL4q
bygeutmNDhLKNS24vLpzgASWER/sKTBeYk4lz6Hnf7hdhVykjr2oHz3XeJaBgVUPgXB0nV+x8rC8
zFiwe4Vf3F+M5SCzV4OqibvY8G49C9c9LwG22P0bWvd713pqRdi52rqF9+wOJt7XJTMMdHFPBjU5
ebn9nBKZiSIDkKtT35jf3BSco3th4W+ay/mHg0tPt5hFI7eLNpmtcDj27BuaINgScbgCTSTWEeC9
SFx1ZJMGm1o2OPM07MgIxyei+UMc9GrdQCnfMW65lXUCoqhzV5MRPWBKY7/Vjtm48pr6FzwcSCh4
tEZ0JKxh1WsjrHxN5uyrtIcbSHTnWHmT/WKYbb6yCHKtswATbGc246mHvNgq2W4MK+x3ZLrxXtYT
fnEvqt8Z115ApEKay9WpnsExYSVxN7yvYrFCC8QnWMTzeYz7t7bIXOy9E+sc2xF8i9ZF+SBDNzmU
2gPdOZ9GC+C2bf12raL4oW6DB6acJzAy3arKE39fLV7ldFLG1nCGdG1qzE5wPa11mdK0I6xZk7uE
eZxQOrjyk/y1npuD8kaWM1aWlajVdsrBBmYSWgO6B7ai4gVSJQal2ruKsInuhFdPp1KRtM1jLvMI
Jwag+BDe2X29EykA/8HaMxgy3vDyW2s3M/Z+DvGxAHK6J0l8TTxyEM30Gvbta+nHzXqYwqNSes9q
thEt6KdmtC+kZCAZWPBOqvpiz8HWlziY4IRIXl5schbvSeer5zIZnbWc9bUW8vtU+A+gIvFUC/MI
yrBdG543brJu2CZh8+LMxosZ1+Jce+Vt8ELMK+Vj3pH4TOf4TfQ11kmeO/IRFxC5Iz2m1uJNOM0z
aK+6uhuF5ljCCYZX9S6CacKIXmGW0WB+xy06xhHGpMmLpSnuPVlaJr7YYrpYWvbbuvePMGhuplMQ
XSF8hWJCTrVi1p8Pr3mWexugvtvR5FA7prDIB/NXS7qZZ7eC6gviYqsyVWHRpAgQHFBgCc6sZW97
nFGttCRVMQzuDqi37tapHPwXDozt08J7h/ksjDTfGLCHWFWgCICRoXJtvpcZG+hHl6wb0MjWpzZW
pn10V+PZuYGaqH81Zc/iZ2gykMCMYjBjJNpQs+LWMU7BiOazDktpfaHkyFejz8eDIaLhvsU33u7N
UY2vVUAkFWQw+VFhxka2iwmcX4OK+flGm31AMb2dZVui36lHzjjEPSyaodtWnflc9lFnXjrZqme3
aqOrhaq8gV/6MFvBs+9NNxOF/2McR2dD3zPrXQWd4cPW88NAPQNgNosuhHAiPWBGSZLthBDt28gX
xB3GxN8PcJOGTtTfpEXIVKFnARF5F0l0Fxjh8+hQQFXwe49j9hhweM7m7mqF/g0huFjThwPG2JcP
YKGQPigfuLNGgyQ6TrLgQ0ZJ+hAl+LwTBQusFOtgBng01c5HrT21za1gOGYMiVnbywGwdjDD9Te4
d+Ga8JbRQ3iabYwbEC/Lh7KArdX139IYL31Ti+5ZK+sNwtCrUmT/zKnGJCJyKOkNwkhRpocEvxyH
jwBDfJjM59jHX5eo6FsEdAYZUuNLzVlUVlkjXzOQFU95FX63cp5cbpJSAqXvaJwvbQzgrb1i+1fj
wyuLFscnqfo1ARsoIlGvh00e0ozQ9EfDrh/jzn5o5xLn/WgFZ+bsH2WalPsQi9xTBEgB/+bYFe8c
0MKPutDeNatSTEaxlz2G2N1gHY/reGoNyVBheESp3Eyhd4oGd76OPYY9Q4fTvuzAu5jAbMjlRMlF
FKF84kl/b/R4jdnWPxS+Jrvm+WW6TSDDvnAiRnoNmPA8TUStjrwf9Urzhn2mrDO8ZPOcXJXqppOa
/W8z/CFSteoa2sk3hwtyLp3FLqX8+dVwsW/CrYlIPzeeeMlKjvbAYSK6NNr8xZ9REly8YU/QS/gT
XBMTInO/49jiOxmlO1yr2Y8+aSVzP2Uv+9cuwwiXtc5rbRIYiOI8e0jwYK48OUJe8IKePQXjdFwx
gsjMSJJAMVceIAaNlSQ+ODRbEZlM8xvgfKq547IwShv0O/PmjJRRdQOTNLxXETIUj84uhwWD6Iav
kTlJsdU4aI990XZHuGI5Bq2gOpSV7F/g3QU4MH33u2W2S/yXFij2VObOw8Vabqwx2Ymy9G8ISd5a
dJ1nrtskSJ8qThL7bEo/vZLoQkBF8oqUJu0XKn2pImOTzmSS68WRXQPAxdhKF0pWTuAF+bluCchZ
AOjJLVcTrJvRp2zgfC/Okh+3rAq8VOgnb0giE/KJKyBEutLERzWKPcBU1DLj3x7j62Szb86kmx37
NCg2LYWW2If12O96UTUH/MZqM5IW0SzmmXEsJze517lb4WglOrQqI6ppS9cO15MXhk9KpPKuSDo8
tJCu6bPK3rI2jt6KJsEkbzZAbXLiJe8EVPXORyb+SUcB34hpj0BV4D68e2k9jw8MzEk9JLoxP6tF
UuZgVCebkioIlyQmycn1aEUJN9wkoVxh757YF45T5dq7CjIJSpGnaLph7XIMKD8iLgp/1TnccAdc
kUgSBvI0z+8gu3XYJv77LPrJ5RQyRz5bay+sgpMZAfY89kEbFcjRiLgnszVj52cL2Zuns4UBsnJz
wq8/En7m8J3+WBZ9M23t8MO3ini8iLl14yP3YBNuBfOD1yZv/xo/uCxrXbPguxLLqwQgdrZpdATA
B2NTLcx9XQe2xKmm3JKzjhvGTyJ33I8wx7BXc7IPD+qvuYGu0yY5sg+dHHYORXPoRFxRD9CzmzuR
5Ff2LmibdDiUbd5+K93MJA0GX2aAAzTaCda7ESMBiocyklNkjRP4q6mz7WjdWKMznqi9yPJ7u3bG
azZ15FntTtiHqO8p3cHPRtKpQ2BEuNYUK37kdY7rOxdeCcXBaJyHqXedHA4pNWLMxKQIN3U4GBCs
xrIDOzdr8lxj5Apjy5QyJ3VIPA9Jp6/89GTHQUsXA/LpRhvWhnP1nujVjTIypFev/sBYtretYY9j
+3Ec0uF7maAz++YnQDQUweZBp9Wu10CoV2Dorsiz9aFHS77N6Kobr6EkhKv9FrF9jfrup9eKeZuq
YX5roMg4HrLj1EC5TmdEOo5WCAtbSomGzVK+spkSlJXltB7tHCr7OFP+0NFA6oOgBPOhsDF3HNcD
8J/2nK5D/RX73qE3hh/4/11cm1jDU3/chX1Its01nCe08fTZ9jv5KswKk70cP7zW4R0dzepQs63e
claK4CnXljqV/K4rmiY8LjF65LbRxFjSVdr7frZ3BGWwN7zTHmQrn9qicNSUlTRO75E/qqaRR8St
c/vSKVF8UDoY1usURIBzqpshtxEVFloyrEdyvoekiTm5OzLVHj3AkBBWpbI5h3BA7DpknMwHTECZ
/SWuk6nc1pUnyZPoKi629lC76kzgiWrlssDJv+OG8Zqd3fejgGXbGPIhIIrpHqwyJqLiALjglD3L
9M7sQ+Geh0rY5ZHLG88Hs7eseROMpFMuSsE8YHlnMHHAthEOu7JurfTG1ngMn9tsyuxLOgqWArc3
+CeOZUZOQpR+u7ErGCHsVIKLdnCe7sbCb6JdJB0igMRBQw/QG4SGS27Ok/2U2oM2z34rG7y+cTYP
9C9Jstirfy8TvZd0+Y/edev46jRwuu7SmvnNBi5hg+Wa3DXsGN/NhXHnuxXkAn4yoMtAR9nZbDEw
t7auH0JHc5SCgDadZJnzyqPJiRBNAs1b93ZrbG0cCcNr5xf+1tZjBd/KiJpDbnDeyzJ0jGsqKn3A
MDYsw53Xum0ItQUV4WE9MKYM2WDez2GBfT52f/mkkHllcppip32utT09sG63oFVdsgRedsgj393j
S1gsHiRSC1u2e/AhM4xQYGuNoZ21SQPP3iic4Rg1C7xhmbJPIwMswFed/dV5ibFjOB58DwqrMRf9
LPpOvQvtKM2ARYfjvNbJAa2ZTWSv2+lSUB/C7i1eMuGNXZ8zZaP4RJnr3+cA3g/WQkafOz8Bayzx
8gZlOiUb7mW26CA5m+dlfrLrqNn8PuoUiCqNHMVnDSZl22l5CYM0/RhDc7oZpg+doYmHeD94wHsU
ZLrjLMRTZxWYe6SgcmjMXRQbKqMQt5pgPdV+szNC+CExS0R9Gjl57eGN/YRXmWzgJNRPliZoDMTY
IUyhpxl2SKl/+Fy0p4g5yY80LgY6Jfxm0xZOQQOOzMwVQXW+0ymmTqSY0LFmLZzD3NjxqTCD8ao4
kl4V992a0txvDl3e8ZqRrPWRIRcwIVMthVmhM72kTFRfid+Xt9RU3+0BBYcgjrfNgRrdgqCrxm1K
FibXgPyIQhKZs4rqztNaocq33gOUzwEeDro1NI0M9kbRpP1R+22292ho/Bho/9tX/VBeCKE396QZ
upVCiuSYLWF5RMtqV0evJlHEs6q6D00AhJJf76jiYLzQ4uACkLPbe79VQKZDmCw5V/udnooY1nJt
4fHVxSKGJnZf7hgb2ttM1kG8kcp2PjojCru14Re1uW1SYqDrdHCn91qlCcHowLA43yfxlRYG73vk
TO132Ki8JmxxM/hJd7Y5uw8dKV6i5ZTsnMhzGOCJmI3dD+xCdo1R9F+OrJtbMUfN1dDdKTEVApHp
DuqAcoA8JbWNImQm0gE2Uc72W1STM2knr97a5VTcN04oDprgFRIllsZ5bcLY2ueJgGqDI4eQppij
H1EATc+ISkHnJANsZq1VxbrqdUs2ZkQQjsANGql1niPEQdN3yUpHOeCmgVC5sUloWMIHEPlPne5s
ELtQtxk6+gzuosCi+oX8C1irTACKLubd7Ij6jk4B/UFO3ablg9AXXQg156H5yHElJOcMv2xj54Y4
Fnk5HmsX1UymPtV9MXoVCBK5d+oBDhpdR86NHMzwVjWV5dP0VU93li8IZIcDmw5dZdt5Lrx7RBqy
tIS0ezkfOKPFu0Z0YA/E+Ijvw3ieIMvcNJMvNq0x1vO4wgLhi2RXZ7H9rTEXMgt5DBviADfhih4x
9RjETPm9MsmOvu79Q5WQl6BRDxUu9jeJJ8oTT+sxLaL5DcccynWIvigSV98MJ2iI75fDAhlJ0qfO
Hszvg7TCe4LUmPVtK0Krca0Ha/RfU3fRUE3AFXsYXDEpTPwDWO7Ij9Gkw7GtoR47nu19EKXdda46
oHF5FnDrA0q3h6D5ytPiZ5YAb9R11733iaXu69KpYex2uExV0/E5zO0YaI9rwdh77Q0WqVAcv6dJ
NTsvM8ngmHLn1MZhDIr+KF3SGWok92MN9ZqmkIoU3fTWWEmyxSzykufpp2yxkpRGzqG2clayEJdS
+rXDTgFPYGARWRO1S/LVtOC5GvmytYGaTAUHNb9oJ+Ml5cTdrOYxekTuLs6jyB57Ns29l8fupmw4
RMBbxD6BtfZUjoL7VE6chsPcmKJzo+t45/d9eMbL0XIhWA79wefdm6NTZT08d2DPm5T1c9sPIV3V
Q4NdSvjbsHOelUg+YIp5O+mZ4Yah35Ztl/lCFPiAnE6Y2J9osTQb0gIZoRRw9evYHgAYufb0MnsV
8fUqHrAF5qBIc2iusAwIYvrfgjzIESXVRJ1VbMLpcUizJhv4StWmgy5M0EUWxjkzODGX/WA8j03V
nqxuoLqSN/NKRx3MKxQzhPaxeWhqD9FIZfRvunl09lKYqpR5dNAHqLxxkJZhJYk9uiHnDw5bsBbg
O81+L9ZJnVfPsTCwJLGebkkFyV3JCxD4nZVsJyNXmwp95Q4UL3qvoDiniE1ylo3ygRBAwItkKB9F
oKYLvVRQiALOpzlqJL17xnGajFM5dcLa9ElZXlCq16LVP+JO5teuk/6ZAG98sqiBX2A9zUvgOeZZ
18K7UO5YfyEQi3Ns1OHZNIt+FdgxuPcwEQ+4uIxgy1LGZIFRGIOdEPQnqPNDBdd85XvLdrEEADeO
drqdoEztLMuQICVS2V47WBv3XsxoIuRM/1wZlXcNcJVCGkfvssIZIHAPVuRRWNW7ZzfFpcl4E+6a
qS8PqirdbeyQkm2ByH9AfQfPvuS+ONexMufW2R05dd1NSNmP4QBzlglGWJvrHjn3ZPTIictukSlP
CfCKAPEmEAr4JZnlkxoyYkoBf0GhMVklA+rljnhJc3IhklQrOke8U5kSGmeQXf6YWGnGA0+1/6TL
FLhoUsHbjlRD0qXtaP6aRpM1IAYFNGFJO+Rqarf4D3ja6PfR34Il14Ss4fmg6EWf0jLVmeI8asM5
hcgl1truavXihJb4FXmTf2g127F+ihzxUkm3uQ2OY7wUYMvudKH0aW7nb0nt5Xcjp6ubnUh9ygO3
fCSqCgMWJLd9dFXdaaRya87XAwOwjV3AmG/FCE8hk+BTOROKVY9UXx4zimkW4nVIbYoIde9sjJaw
mwsStluXsio+J7uIKFm05uAlqtv0l50GPnMTg3eB5zFNaIFP43rye8oJKF4hDl8BGn62qon4Is43
4Cn0vUm2vyYNeE2T7lnQ2K5lcsbnxZFxwNarTChNs0JFmDFrUgaHZt2VV4Nstvecw91l6IP7DXWE
Xrn6r4o5WgW0+ergm2DflJD09YoiWHMYd+2DVSAviCqHBDhGJWMNZ1xq8aK+Mqe16XThT9EmdIBa
CisWIa6TZRfmh90M9amFXlhtpD0yqbBneErM+UKaKu7KparPmuePaES/kcDMEYxZxwbqltKU/gF7
FOlOVQZkkMhdDshO+UXM99iKKiBNmtyVqnuLuckRCsfYWtO102M+kh7ijgNGP6gqeHo4q4oHiSsq
3GI0Y9Vjo30wA4josRVjfunspF6HVlDuzTCv6WGdcjBGpmtQq2h4xPJd9YlCF+80ZWeNlMM2gsJO
5BGUsYb7xIiKGAK2a3DuJg6WREt/Rx1FfrQ4L6zt0fv0VYiRAcPkPodE+i0xzPDo/1X3mLW1PnSW
VfMAYXbgnGuspnoMr3zfeIXw3J3TMRnxlw5lv5sJ2+zSJalszFwkUMPVhpae2Dj7Ys6fe4oti42b
D57JvyzuZsecr55fAXGop9CYT6yrzGEVE2I2T0hdzEAdBj4QSwzH245xm8D9puhs+Xdi27BIMySG
8rwmRh6sOIuEh961bQizYiDQhnlkh7IHVrsYnMeBUeKOLAEzIOVgtBrlD/qKJSwedkHgfaU6cLhq
v89FPBxMu8rYOHiApQoaHL7bnWRoWpWO+q6lgR9Q6Sm/o804OQ/0njYr9nsBcy2OymEn+o3Riyvf
NotzAwJ41RXlDO0TUeCfDZzWkkH4WwgDWyVOHFcI8lgex17vD4t3CcTaAbn9X5b52dMT5Xu5Syka
4jvGHYctAmvWcuBsVXCE9d++M5BXDHvbhoqS1ucAfIBbQytYPRaYWFkNx6vP1JHdWDIW6Wpu7c4C
C0Qy9Gfe0lYI2akEPfXXX/I/iuU9/3/YkkTS42+X/P+qSbr/OfyvHz/f/yw5/+v/+nfAzzCV+y9T
OnhL8XBisJW4q7EMLf3nLhk/BcyYdw1RK5Os3v9J+BHZ/JdlY2f3pGUqy5Mm/9d/RfwMaf2LVnTB
jQXAX7ERd/8nGb8/ki2IqSZ3KaXa/CyJO939I2phiRHnZJG0b5ka2fSF4fRtME0b6EllkPxvre9u
0xbmxiXzDwyG7DNZxeh9aCXwfemn3X+IfizPxH8/M8vv45J29BzhChdztvlHoiieo8AcCG+/mdRr
nlnNa2ZILVN81oD/kFNY/rTfPspifE5UwUI652sUf0SIYr+YQAyOyY8q2Hv5ETf3ilDmyoPvMY3b
EUsshcf/IQrg/u7qlh5QHJcoAEkFzmJceotf6m8xhYzyqkAnifXRafDm66TwLB5l7fDMF6Bt90ro
KgQA18st1a5GtWamAMy7J2IAWzmkzn2xX4TzurLLLscIUXBe7aV2EVdURcjMb0Rq80rCSr0L0HVq
pEpFQ31kpClwPryj0PlKDxVzCCHYVCOnB5tiikUeSylHsPzY+2n1qWVuaAboIclyqREfg4XyAQOr
s7ZAyJD/ywZEFQ6e9qspY5fxXzbbejt6DFFWMNOS5wosMFuAIQMf1fAkPI+TC2+yG3AIH6xmql6X
Tbha24OM/X3M+91f51VAR2VSdTnl8eVinvF8NinAHnCynO16sS7auZlcGn9h+ZTdYHBcMDLbwkEe
VhBA3RjI0dxM1t2Q+PyFMZRKDDkAa2GxOyCYNyHl0o+T67BR/NvTf/33rfP3uObvNvq/ru3yKJPX
tHl2xZ+xQmInWFFzzZ7EnNu9Bs916TtUqX/+lD+fEAi4prPkAZYgiSMdlqi/30ETTtK0EoH4qFSV
rwF/wHpWKS8ZzbH2nz/K/P0NtvxFfBYPIyEl/jBp/7E65LisdNxk5ocYeFj5sIopXN+biHJ1I5aR
N4r1UzxG8bPb+vS/QtO3SHd4sJ1UYDrbf/59/h9/umv6nNt8hoSsgn/8Oo3WIWsHA42qCN2dNEHk
BWZbHfSk5tM/f9TviwPPJauPy2X0SW3SuyT++JYjL0hCqyvyN9b2bMfQ2gAAutT4TARhnIDRonJH
ZxWiXl+aQOQv//zxv/+ly8cvH8xUhOy3sxwGf7/I86QhnZq5/QaYoSD472nwPH0HbU5Gu3/+qN/v
2r8+yrWJ/Nq2UtIn8vv7R3kgeSPaEJy3mtH3dUhnZ+f14BX/+VOWFNF/L7b//pTllmWdJSpKPuv3
T2lCAsuqrdy3so7oGFeMR/Gy02w9x9PZJy7w7Z8/j4Hzn5/IdbNNwJN/7cFoJfz9E9vKI0tRSvu9
j5P0g8GBF+4NPA3zKm51X1ycnuV9FRhu59F81YXpFh9uARDJi3GoIDza9T53EcFgEapc7/pBlR/g
92l36b0W9E8pzSg9dlbLRIAEcfExKp+z7VAlNbviZLK/ZAZhlERJQcesExjRcWgc3jKhyYK554Wf
fM30R8NxdMI6PkJatfU+mqQ5QfFp2x9BnNjhwZO8CLamckBXz/awuFGWHuTYjzigudoI7rVbBuk+
Wcy/SIwq85/zXtEcUmewamSK4YnJijtAkBhtzkNbx+/Mr8Sei4r3Xq76Y4HGy8ixHNuHgWkd7kg9
yGo/iEkKyDWT6UMgcezX0am8lzIidUrM1SILmuZgwtehW2WH3p8NGzndNvH7YHlOGDwHvnNHnc4I
dzUMXfMQlZaa7zoPfe1gI8hY16iaw/SACEGGJohlj9/EpIgucM0MfLmjI/Sr2NIrSOBJtI8bO5c8
Aw2EL7yZyKp2JaD3j4JM6p6xDhAV3wrRmUDiF+bV56BOXVhSB1RBN9UwwgYdTcJGNBEQ4OW6TJvc
GYYQb4QHnVCV9MEoX/CSRXjTWz8S5PGU65q8RUVeD7jxPTGsLPiZ7SaWlEDgnmQFSAMnpIo69GgR
oQdmFxUcd1YSrTsBCeX6z7NkVJSXSPkAdbW8FaEPUyYp/Zwh3CCZ30E3cL71c1PKjU19MZNMprAr
kXVJjYPYRIxDzkPxHjIri85mtfQ4UXmomiNtgkArZ5VxHvJsP+/IFubRa1f79TfNSPoznfzQPtUc
Vc8DZ9tgwXeU3pYqPuOLXhgqIWumoVD049J/mbUV/RpzbClINTZfk4/NiPvZqJgGzKD0XnEx4SqS
Yxeqlcqt9Iq5mXK+eXAHppNazWDda3cf0tDw6jotRmuz7TBcORSxgA4UVrwjEo8MODkqxm7eeJX/
PuWWekWxtU4jged+TcP9EOMGoCll3UyDeQWNrhGSJdudxtWuA15mrpPnLCLdCwG48uKvlD2Od99m
YfQQdoXxIpsGc3cvpnS4AADCWyp8Bj/nWA5AF7HvUcNZTL44h4bGMhcSskZFMoca2j1EAAdrZVAl
azwSwzM4KJFs/XZ07vJBeC8AH/23ykhyvNamSy2E9rlNU7vGO404YzzWiVeye2lF9hBPJvoh7H7v
huVH/jTBBPxiyG9+a/KA87mUOrSOmiYc4C1kyZNDOHgwc1La80jKIRLhenWcG/lMfOVlWIxbzqw0
etpZDa2AP2Gst9JSwLeQCaoHiVKBDTykFKlS5HjYmuGIpmhskNsEhNyzITofml3TU4pl2P3N1l3w
VntBrtZ5oK2b9Kb41awGPCoe4adPCiqyH0bjJT+idpD8KRHlhPTNlNFTzyUjZJB5gkdSBO5GytSE
W4b4doeD2ApWhrHEt6eezAZH7R7fUtg7zWc/jCUBNa/HCY85RX1U+CKJLgGfWGiGZJOxjzTNL6V6
+pfadMJBOhvZHdm3dsn6MfapsmlAxSwIhbBozOgEsiiuUUdPFiUSanGxZ2ZzYxwEy03ZabwkLLLa
odCzD78mmWGxGu0Cg3ykge9hOAlFve5Yw641noh+M7iG+B6KlKMOrgB8KXnq4ltKBZmqLBoxuSpk
zu5gQnzDdZ37Ptoj8bCDHNj4Xfx8pN2itUzcCWhSEMxYsyx7Uyi71GR5eezXQU12A8f6SPqgGEv3
mztiCyeIEBgPNbuAeJvbOdZmI81mHENxkb2lqeWAvpfAxVCjspRBjTlhFo8L/60N4qzZMjtnntHg
MpgW2A9uiUl0IAuc0UAgLsOcRqM5WhrNmjEcQJQFOZDPOgSlS24k6je9kbQjBKBgYpnLG1CXaq4U
scUu8RHaKMIbNtZsDjBIie9uh8pKXiYKKkuo5sr4ynCH85galKPCpsVxtJrDoYNzSiSh3ThWa2q+
Pzcu1j3DU5Kas0+ISeRFLpHzu87eMoQSF7tq67exoNgDBWfKj0M3aYBGttYWaDVVeUe7zHtWTT+J
SCSMJjd1wWEVzbvCPr1jOgaiCztm7q6IuCJLE3fzg7WLpejRMdLwk4qIHmxpFUFdTqr4kdqd+DmV
1EuswzjQF47flVxPXbdswuac/o+EvdG4hDXIZFMsCVnWMpLg1vUSLHGalZjUG1P94lgNaJFhl/pB
QJSutR7X3jv+qHbeDTlWwkSG/Ys3krXBaK9JE1dWHdKu7rhfBfsISGmhaS8GIGr0YFu4n80czL9y
m+J75gCshBmZ1mrjYNDPN1bYokiGkTc+i5yRzr4Law5ddNLgNsfbVTUgt/X/5uxMduNWsi36Q48A
g8F2mr16WZZkKydESrbZ98H269+ialBWpqCECyjcQV37MkkGozln77VT4PKVNu6w1bp7tJ6cxUw9
6R9T4o31NXdh6UtmEU6lDqKr+97OrbcAPg/FJz/nrDfSKHqN27EBa1rYiHAh7iMbLDr/dajQeOHp
Gyj3mU7erfJ8hB8fNXXwS0N++QuyHboxDsfJH7awtHRICFqr4ltupiQbFJWPnrrhDPIDE0zNAjs5
sbVVhoN+HwIOOu8You2NlUVhuLZc2M/wrWUBStNFWgirLtCYI9z5oGkb8sHNCu+tr4T4jgXV2ZFL
hSen8EyaBMi/gn1CON9TH/ZZsqJB0Dw0EA0IGvX1Qq1YNcM90jKc3VWDBI9UmOzAjil+yzrDYfIq
2sFAg0F+nDUGVbmmvEmPZxCBTUp82Hk/RKyre5kNQ7hmZaRjGQ2oqrOw6a+RCzx7GPlRwwYRqDvw
S4u+IMl94xQsnCRjSXNfERnT4aQrvHCTo1l5GHPXQRzL1nOGFWtA54XvMhsEfCu0RwWNEuwptVJL
GcfRDUYmepuZKXqodUNCBAwarvE2EpEPUFjI9Bb9DYEJZjO3+bMJW/0CxWys1ozcQe2wMhu7jE7L
ktHo30y2wELD56G+G1XOXtIaLGbCCD9g4OManYQV77uia1muaSYBfsxINcBDag8/TL7VZCkNXNd8
n8zCRjzGBOh4+vdkUgK5uB33Bh6jlN4AlWuy7WklBdVlXAfpxq/x3i0rlZIIZxRJdij1Ag0IXw2C
8ZAoPTJoJp9HEPZ+NbymmHOpPSAAJjQKp3+Ut1tfSFKcDJgUkr2DVrICEO8Hia4q7vG+qZtERIGi
4d+hhvISrTP2QQC1n5gC275GFoKQDrRouPEHo+8fk3pC3aMV+IaxJNTpnWay01go0iN389yCkaMt
4c5bqujzrR+nyWPckbhHdraqi21rVEwhej/ZNGIxkPeAgUVPYrM2Oq/5OKb3qpUR0xTL+4VGgtNs
eRE6qU0DDg297twn37dUcDFWGajTlmq4eWX0ElnwOsCR7Mcwwtuq+UYTiNZWgDoh2GhagXIoQXmH
aLov/bcoAX+x5HQu77LJBMZu1G3c7AzlNHcpOhF1YRpMnajKdeoneQX/mC7NaCCL0eowXKGEAO9j
qLG5pxzV6RvH15OrGqf9T5KNvDedNh/I/IDW6bqWIgFNp7MPWQY0UKdln2YS5quZt6QgREl3E4QW
S4PfIAVdGPaEI8RziBrAoggAPyc1cjnVWAtXtsuZmDiJQrujyTUNmwpwGfBkBKC/3JgdCpsATmGU
jZTW7myFEsX3UpvTTdkkwDYth/dQjma+F3UbHvxAB3nIQc7eVF0VP7iAcNPZQ8GUqTjE3FcdedKk
No9zKo03Or895ZvlIs3z+AfHP/+OrQxCKUBS9Q7WubmC1huYSKENsHj0EvVXrwjG3VjWyUPFp7a2
BjBDC5fz8QODwn21E+d6iuhn5w/mwChbxK7tPum6DYmC1KGuv2JBbg9GjqppYY1+d+fSMGZv6ocE
kqdlWjzjhx39mxEiYkQOdadlIErDPiBDV1fBc9CIqCavPouCtQQfCnCSWN/wMmtb4871Q6D6oUZN
FxrB4PzUqLnN2AE3QAM5WUS2azaDjAmo+NXWM4++LCMMslrXR+RWUDQGEj8EHjFrulf+sOrWJU92
IODa4SBLhxFr0WXYVM2zXQSMPVzf0tx2RpE/5oIS0ioM42w2HBNIsAiSxv9GzlaBSaIiIMesQufJ
V3X2bYr09DuH0myvm72OJQszzo8ciW68UAH4fs7m4bNWlPneqsz2tdfT/hltsEQXzeH4ukyTsrjv
3LYjr9eytbqilmq0d3ZYT09O2Kc/iVnyxwVbAuulG51WbTw/tPGHdWqIFrO3tHkNhobOqw/J8RKM
iq9f6ZqB4U7Zpgl5wIuTn/yI+kemdfZ3cn6HByvATs4GOemuE6nB1MezS2ox9ejqtlURPg+wTXi1
JJIjaCNuvTKAktgXIVaIbVYEGmccNZI2WfTYgj1zGt/gXr/qANGDlZ/K+KqluszugLz3VRszl2BN
ijjUjPAaTASyk/VUly0F1agIvI0SOn05WgCQZH3dQAqJiQa5ZFCMCFaJNA045oey+dlQpYGq3AeF
eWNHoS22KjFCdW26AUa4JE4ofvWDN/yIUQJqT0bjZvnNOJYOLv9xarKr0LBLGydpYDlrt627B2eo
yW8nFadvLrpMdsYP2s3YuMggCLAWYu+zAXPm3Z8o76S5ifUijzY46qB0jmEzzWwO0+4vLN9ElgVP
FgQBf+bJRMWf3wc8tJ0V5GV9EYCKancITtPkSiOESqzDus5RbuLB2el50fMOgqhLNiHBPO1iKga/
ZJvkkmHHiZlVTyKrRQdixEBCxGQOikh3ORFwVsJZXrI2YWAvkCiNoJBNL9nnSF5DrKLIzr7pnaca
5DfElRPP5eMioPxANkI0WpTEeRbOtOOVOGStEh8JJwTZAAtbbIT3SsmkWeJp0MRy0IF/lIaQPzkc
4YGurCl9DqVhssPTubGNX3K+8WJ2PUgrqA+uErSNN+lADDH/zabKtg5EEWKag5EOAYxUkieFXxTf
k1DFPzpGVLxsbQdXrp1YCV9CGRXNLiIikvWg5lYWomrNasuiOIJdEJTfB4oy33AnuvlC18qKCF36
9Us/ZTxckSc9Hy5lklmkufu495skt366Zo3gqqfF/5ilo47HtUWDtPw/Ku4GEdatfGkhG/wuvWhM
F5EeyV9fl/5OCpoO2DudNgvoKahoci4M/tVi8cmsxOpjuy9RFolrvHXih2Qf9K9l0/kqGCWojOpz
qXgueP51Fex0FRqI0UNDQJBeislnXaTizK2cVE3fL0It2JWuoBp8VJtNUpsiEFXbl6F1mlXnSn9X
WKj6HaNgS9zGw5kC+8fuFFVarscm3KCs4sKDOq7SDk6klNtH/gtZR9OiMBFPKCyeN5RZ841PlB7c
4xEp7hSf6TSc3qhh0RGjMcbyN+PQPj7NuleIoFWS7z1H5ZB3/foKZESzrKH/gLxs1bevx8hJfZ2l
1JC66dh04hwu/PF6DWBjp+dEuCeqjVx2BZLBYRqFwWGfg8x9fSmpH3GcHHLmgCpLaieZVlwR+Eir
LyRnzQy18gyO8WTk01BmmLDlgafJmDka+Sit2Ng7Qb5XBRxgYB3V3Wjl7eO/PjsHoKROZ8LiKuJY
1kCdSfnDlOZ78MuE1HAY5RgavrbUe880DT67n7+vdPSNwY1gcdbzfK+5gbqQ1DFX0iv/fH07J0Nv
7sLr9tyz0w2aIEfvp6KaB+Oqz/eEZiSbunBhrAdG9TJWjbztoQtdfH29IxocHxneOA/wIO9J0Hi2
jt5SAy+zJqG32Y99ob0EWplnyzrRrO9ZjeNN2XG5yzFM+Kka7nXU+ButlhWVyqK2v022sski7auf
g6n0Mz2v05HK54eGGeYYTE/zvRv415QmRhRnwNiavcUEvW0E/a0WdsEFwtq3r5/BJy8WTQyfn8WW
l/8df+50R1iZh2qP0Y8ghcJIVnQP/DOTymf349gWnznicCrf86/4636IxyzLHgzHPk6JPQqn7NeE
vHQZ0oE+c6UjGcX7O6W5M684OtA6PsCPlxo4Fjp90DT7VOvw9reFsaOIn99xoBE7DRTOrkqn8AZP
cvec1iSE2KovbybRGL+tLgjOzAPGSfeSlY8qMm+SGZ3pzTj6OaU5tbi2+31o5rFY+k7HwcgLY3ub
sg8xQY84ibEmTNrZYSXHxGE3TeltYr6zewBW5k/bVxWGe9OPvUXfecMsOWyh1bPkjxc53Cvyd+0c
8+2YtsGurGR2ozl58CtFun7nWn05raAtpE8a8BR3AVsOduooJxhPrAF3WIzPQhZPlq75llkkkXQI
vmPj6JZLTxFr2zt0zUB4QA5ig9Wyc9wo9gKr0LXCn2wC1IFe2bT5ejB/Msxch/a3aTKa0Y0dTSBO
UcHaDEW7h6FV7dndVjedLbKNWVnN6p8vBTABVKkOeQb499Gy5UgsJMlEBBHsHtDvOrvkzMlRoNb5
mZs66Z4iMJgHj5AUzAyhHw3oEjCRJax82tPQWU+a7a7Z9uJZEf1vO45iOJnnaNAnj9FD7eTBQp3X
L6QHR3udIcVm61K83acOoS/IRAVeWvASBr2q3T8+Ri7F1+HOd4eS4hge3LkGWRAVUStuSz3Jj5J+
Q4aSWLqG4595Y6czA9eat4kO20SmVvdoEiLSSbV+6bZ7YmqnO00V/r1oLPSsmTEtQW4Biqq0+cSB
q5+z7U8t5RyjRaG10qPBfv76xo8oqcxT/BoHirGUAlKq682L4V9TIqbRUteistvHnCwXnYeza+i8
bkPXlFbxINwHPyZaxhO1/YDdU19zyreeSQfUKbd4WyLY9Jevf9Jnr33WygC0n3d/72zKv36R5jQ9
jQLZ7dtWj4i3SXQkslZ1SU373Ah7nwM+iBA8yzIMXr0hUc4Z3pGqIrfLvuuNdthrjg1/kOZ+B3Mk
94ACTo0z3gHq59jltsbw7HotBQOZWt62tgpEAKnK+lvNqYcJLes4A866FNGV7jT5HzN8r19Se7uk
lMfptuZBvdrUSJ5FT9Y4CSf649ePbR42J7cC9pr9pERQcTyEDWxkE/6cYd9PeQ42psMr7/r5mYVE
fPJ2LN6NjqSJc/bJNEDapS3GLB/3uQjrtVY5WBbLqdxUhJk8hADklzCU0DojTb514qi+n1qTJzZC
Q8WlS5aJylqM+ra54+Q3nPmM58F6/AykM58WDDo5xvGnJeAgqWiKx/0gLFBZdZetwyp4qXy+sRBr
3L/uRhk9piMNlyfhMnyO9m1QXupZSjDuaVnQ8vSHeF0GQ3lm4v3kppDIgIVmMROz9OrjF1pLRSKM
UZLkYmN8HjX4jsUYEYipT9oNts3/4a7YuEgmRGZeFpCjGcFoNUQmWJj20Ai0S80oaNe7RrL+5+Hq
CbZ8rMvAtqU8Wp0hc0QZyuxxT1w2LyfttNesIH3s66uIk30PqlgDuLVEk8G13KOHN2D8dtH2i70f
Y85oK2t4xC0JqlGZdJIAluhbVbfZhahsb1E0pr8vKJou7Eam15GVV5S72DKMVMtupBtBY3Aj9uGe
uCKUuF/lfZyfGcKnnzH7U0D97FkgnaMa/Pi27QxPh68JsS+hTW7KCv5t3sK2+Pq5nH7FXIX5DnI7
JUZpHe1Qas2Vre37Yh/nnr+NOz0jg8qHWal6eeaGTocvwjlmWXNeZvgk55/y13Qe4yn1YqO09q5F
gX90TJJSndq+8cxquKQlL1df39rJPoUxy6VmKS3jyz7G0o9iDs0udW/PfYutk4CnpVdlAxeop0pQ
k4/GbUlt6ufXl/1kIXX4YLhLY15MSAr5eJ+GlVLJrpW2R5JF7DqNcu22rOyB9GJG963WQWUsxqRs
vxErDbyaDSh0XSMjFW6yNW8PNb8dlsLHe3HmLHI6pOZfNhdSZng0MvKPvwzSjFeASPf3Cs3Kdz7t
8CnD1nvmKp88d5NFlDKbJTA3vG97/nrPvlEavqZibZ/0IiHC3KhWdiAqeoJhTTCvHUVb2UOJ+vqx
f3JVhhZvkuUbqeKx9lVU0gckTPeGwwUZzUKYv5MkNl5iDBBb0ebWOvHS5Prri54OaYSRNnEhHCuA
5h2DuJuxmrzUm7IDvLH+woth2MA1p0TfFOE21sf2+evrffICPR2aKwk4KNN5kR9fYGVoOqyiIT8w
xtgisq7dRMj6zswJp1cB4o62lUFikUtyXFqk21gZtbLLg21Nv7w5+1pvsnOL2fHEw9Hb5vzJx0kB
cw4I+XgrNK2MMuMHHErfuWFisq+cEKJyaBXW9t8emhQzfxipFYaKmU8z3+5f4xG07CBK9qmHTLnV
lYWudzkEgX8mZcA4fmrzZRh9nPSY5qggHk1vjiCQz2gZC1PUA75qa7KZbydvMoatJgZ5N9pBfENz
wusWRm1nt3CaxtmtlXZXntVZ5MvQC0CAr4zNlAupkSYtconqBsbG4Im43OaR3qhFBEMzXmmF6L6B
0/Cea12DRalndWpwmtYxCn/9+I7H+Pt9Mbb5YoQgE+NoOss6gok5YPP4iIGGf1mA0Jvtd5N5hzwh
ODN5fPoU/3s182iEI830/Nzjaq2CDy2VslaFQ6rb1/d0MvjmdzUvRew7TKaLo8HHfkOJzHSyQxUn
GkgO2S59r6o3ad/9/tcrsfucdeKzKYfa+dHuJmzaYJoAmB2ClHfXazaHupKz+YTpYPXPlzJ1TskC
tDbNjeP1LoO4kCbpQH440ISrtOjpZVXKumSGt8+8pZOjK5tBvAwYVljN57SkowfYx2nYdLmZHHJF
jF9dmmpVoO1HZKzAslgmFAJ2NCVo8DH3f3fYbFeylv01HsOiI5nQTM5sLk7HzccfNP/7vz5ysplI
fwdldSho6F1YIiPtOjXY3n39jD+7jDnPV9SEBTEp8yr012Vq4WZdXcrkQMKBvqq9TL93ZV+8fn2V
470qT5dUr3mRnjcQnH+PrkLyjMpJgzzoHRgwK9Xba0ojwxXSeO8HzUXOmdIL19NYIqj1w/hMB+R4
KZ0v71IIYLIk/wPbxMfLO2YLUaYbiwNdOIew3cFdMK20W2mN0SqwEEElIbuor+/5kyf74aJH04wP
lRkFoFscVNJmOI/7atu6XXdmmJxszri393AdtkA4yLjRj/dm2QMKe78oD2FShj8LNA5I5Crwz6MA
ypiixgJ+SXefcdpuA1uzlzFhP2Rbe5QlJ+Z+SmuWt/763k+n2PcQMNLV3i19lvHxR8UNmq/W8OuD
iQAcoK5jPbsoA9EwpuKmVdD2/vl6GE+pSurzDlV4R19vkrbwGjg+HqipTRAenf6+qpwBRleu35Rm
5G2+vt6R3ZU1l8UXGTKHVkugPnCOLijLCgYVitSD79QgM2JAKMYiakByLhSMqzct6d1nDzTyLwCw
HcqEqdqFROmSQ9n72W09MFphYI7ehcU22YbQ23v6qsKzBaGQSANoEvzhTV1iZ16Yg+v8sUkn1M88
tk+GKP0ZCoPMAFgDjyv5JtDJVGCMP3hpKxDCuM1VIXz/zMM6vQpnVLR2AIhsWrvWUSWqBZExQy/U
wcqaYR1okY52ocr/+V64Cr5j3dAlhSL36HOL0t5WJpK+g02Y+lK4SQJ8wJH/+lFjazWwa7o040zc
EUfvvWHKjyKZTIeMI99Gj+Dcop2Nznw+J9Ol5EtmzWPSnE97s5H270l5dnWQduy1BzlkrUJPS4gr
9blYrP1A1Tcxfv8LlHokxGAc0DEceumZHfPJfoJfgBAUp9S8R2KAf/wF2TRy3pF6d8BsbV6NXT8u
Q6v2CBHprduvv6WPkzNLLt0bEt1sg/Mxo/F4EIq8bZvEriZahOUPZJ7kvtrtNCDmtuTOspClhNFY
nPNoHeVe/ueyTBdUYjEWnhbU0MTA7LfEtFejLB4yp4CbGvQd2tzExiu4nEC1XpIBpaHylWGnw7YY
XDZwMVDsMx/Ix4f9/lMsh5lk7hGa0L+OPhAjQlqWm5TB1OQSBNGRviMA3m/LwWv/qe35finulZO8
jlmfpsbRpRRS3TSvbVwk+Gi2BX4XJEGhv0Ngeu5sfjRHvl+LAwIDmQMlsKjjxDnpaxmRWKkOhiwK
HJjPY3JfxD5aWnblXbTujaB+BBwTzzwuut8IjTtiUGD3V9c6BGkCoFC57dAP4l2RQanLK03l1V2O
iE2794IkuETApD1qgpb8Imd0Pbrgjp6+Hp4fv8X/3AVTCq5xSeHQey/D/bVBGiO7JnNbZ3hCEXEw
cShxZ4pGIZPqx4eJjJlrnDOgIEGd3Iyxk585hn0yOGb1xlwiZeKh5/bxS4zGRkttOU37TiC6bjQk
bhF7JfwfdfHv45DvkBYRtUte2/HWvhtypTRV6XszwqPdkvh84flpfeE1+EO+fqrzjuu/5ez/PNX3
7x3pzewpO5qtJbAwmeuO2GcIS1d4o8vfjZ8Yy4acg5xU+eRaVZp3GeoQg7++8jx3nlwZO7FHBZK5
1TiaW4sydroCW8l+SKv6LWbRWPOnzbkQGl5MaROf65d/9gIpbMj5VEGN+6R7UeTQ7SeNTw6b5Qqj
knvZ9KG7Ci1Rn/m6T+9tdu+ynrugBej8HI+VTph8WJXcmxlT6jIxo3gjvar6adj8H4sozMMfXz/N
I9f0/CINJA1sQQkMRWEkjy6J1VT5hD/pezeuO2fTuWZZrXFchQ+91/T7HHgwvvQkSr51piznnJT8
2oG4v6z4L55ZnE8HFb8FyoFF84IT3PHijJ6zY6s3l34RWETom2L2ZNOIx9KgdIEXM04fI+iV6yQv
jbevH8THTc77c5grZiybM9XhRI40QVIMbCXlPnCD7jKd/HSleyiSv77K6VhCR0NPj1okn+lJWDOw
iCnE4OjtDY2kJH3wIOHU3SEYVXJmKJ1eCVkMY5bZmzhfGokfpx1jaHrFXBcfaPSKlYjJuLeAVhEM
H6lzR5jTZ8duVweDj4zDnM21H68V0pmvWk8lhzLw8pdkoKuGZtNYB4Bhl3UXFDcC59saJ6/5rPW2
ybSvALQDcVyhAEdT0yJAhiP2b5ug+Z0ypE0iAmczt0Vv8OPvmgi4c7XWSQ+9G8OVa0hNAn4dbCFY
n1ssP3sENBEk3y+SROabj5dC3DyElhUQr94M2VafQJgXoSkuvh4+p1stWLSe55mexREGQdLHqyi/
gXGQN+WhG+DT1pR4aO3qRPE5VoT1YHBekDqo1dcX/eTWHM5mnM9g9AE9mb/avxZQjIFW6EzzRXtL
Lh2IzxfAsMwzV/lkvLIdn0kGfP/88+jWyEXWhmGMK7b/KdC9sEJToGnGhvyq+Mze+L3X+nEJAQho
E3HFMUPCRDi6lo3Mqq0J2jiArgmwWXnKfnMDLbySfjLcMdJB9rO1Vxi3hAVHgXBqDuDu6Dj2sndD
e8cJGCb+VKeau6BCJ+m4l1P3oLH7xZ+TO7BZezk1j8YQEn8DS1JcWpEu46Wt9QARBe4VuWgHh1FJ
LVj/k2OxcIHhpdbTQLWB6AfmHrxi81FooRzI+AoF8s/Cz9qXrLT4jSgi2mVN9uIjKtjuV9smlGol
TJSSkC06DxdIN7XXSc+AOpJGbG50HUz0kkpCh1+ZbI23utC5zQgdEG5iNIXTIqyVcdU42NZpHPjx
L6erDCw5uRzu+z6ndFb4dTFAvRYYM1U+TvliiIFYXUE0D2B2F4keYhXSA+JO8DVrkO+V8RZQmntQ
QTj8KSwM1rRffDz2g5NWB4tUHWNZK919zWWbYjcnfeyGCJtBLDKVZJTFHRXnqy4F17nMJ5lh7Bsm
y14aWCRw3iEMUevMnUEf2P7c526os3NFzE+2wQx6h4mNXi0lveMNXDoYHcMirw82njs4eYgtrhI5
/o7mVJzSm63NBMDvItEixzAajZ9ilo+1abUbUBjhqhIq2YytVVyYzP8XUxO66yan3BDoarjk7IdF
s0yNCwAM5plF4JNPl2qybszwIOhO79iJvz7dEO/hYERjfcj7mjyKtEaXbRPN9PUE8cmnSz0FRTRI
JvQNx/AKEqzg6Q5NeoAdaGxGrwePO3VYBILR+h8uxQoqSYamEEHn/ONcFJgS7pgumdE9kOYkm9sr
kSrvAu7QeKYe8clcC2rKpSZPD3qe/z5eikxmP+ysNDtooYHDlc4Gq0dQ51edNhHoVivfe1DlMD78
+8N8P20hlaEYcjzbgssASuT4+aEl1GslpSxocfiSqA43PLMZOd1tUs9lu8nwoBmNkOPjHQqZx95g
e/mhkKRiOVNHeBep8LvebLWF7Ot48/WtfXJkh4E7E7PQbyDbNY/mXQ3mbW+mKVVkmnxr4gkwWsV9
tGqMjnqZ7vg/NEJ41zWbgkuAddHapBF9Zo95chykXECsOMPUpTxD2/LjTcuWRFBKWLxWkj/IjMjl
jbSUf5tpIroj9MffZPzEBX6PZF2NcjizzJ2MKo7tPAGOZwxg+tHzt/TXF2k6cQBGJBMU0kXzk0H8
W5hmscHQE1+UKLp2Xt8UZ97z6S2z1s00ZbaenJiOWyP5lHsx66BxACVfXFZYi4HP6xlwqbxo7pO0
x0/ftNmNU83QyKn5N/cJ2zDumb0DD56rzwKtj/fc22mI2F8aB9OvCZC1zOE6nqxzu9B3Hfbfqzp7
XJSC9LQYzKj9j7+cnvo42rDMOlCEhUQOrJ7VGYOsd1WUQdrODA3AxSYquZ9mg9ENTEgATUXneE6w
PdjWWyiY9ovyNBAGRVZjWcrkWBjYisiOWdR9rz/AHnGv2kK2N11OLprCCULsdIoBtaBZOluK/D/O
mBRvZBBQuLabLF4JRptcNtUYhyt4PWKHKbu0ocOTMLIIZDe9aAYgZxzmPs7voQqnNwm2BslsapBL
a8MEe3L9GguDb3jpDoCVeyHGrgEYDHy1AxbcCAjhjTd2sK8LAWAZH1SFZAjv+VqZoXUto6DrFwgl
yzvyCg1zDpHUb7XW4tcD3ZSXgWVmb0MSmYDIGLjLDHArBJ8iq9QCL0y3bzCibT3HBD/nQ2kez00N
81zz8eVh5WGaNRCdstQ6R5/lEGAwrobBPEy1749wjbpsmSSFabMRE/YFOxH0i6Ivonu/SbyOzLMA
o2mlsclbqjrMIpKLjOib1DTnuSQqnfi+wTEfxj7qbgXPpL3MU08782GhMj7+2SbuEgp/lslZjjbL
/O//+pwBB4g+KTG+SlzVGH7buHupc1DNCydx41WcUx7BAzsDDgxZkVDZAjJ+DKe4OJjxkNLGIj7T
X9lO4JtbgoSbaxU06jUNY+2715L9fDnkBqQIIVti9iKvHq6URmzyMieOxtl2Lfk60Gbd+A0/uA2h
vsKsQUCH6712qjde7RRD7aIGuUGese8MREOmfYIGpu9wfsO1gcpWGDl+LQ8ekbWZyGaKliJtyjfg
Plq9Sgote7T7bhi3yKBNse49n1xTRyPFmUHnJ953YF35SMnHhcPlE+/xHcTYYC2jui/uOHIR+IoQ
vCW3p5hePH8YrwyXXDYSz5vgpk0UvBJv1LBvhEh0YDWZ5ggLKQ0I9kpKbdf2IH3XGUlseHeHWRmn
EiwYywjkGW2CpPV+2kULPEE1abKO1Oi+pkEx3WQYFI0N8CyNEG6q7Ie8NvW7Adz5C2VKOAOdbjHx
JWPn/DbhkIoF87D/LU8yt0MFViTws9Mi2BckseF2ht6bL+FxsNVOwh7aiawho5qqfrCKrPSWekNM
GxyB1npL+qnyeQeFVa7xmWoQiyKoxlVaFfqNXg+es5rISygu0Vv46YboieA3yWS99jxq6ItXoS6C
ahVX8Ktv0mrC8z4hxzgQE1aOt56VaPE33Op+vLdL39KQkVVEk4MpJyTlQep+SgYna1tB/svUDV1I
SvFopzc9+dgBQYwRaewOvWJtWdRB8RTjzgMwn2iJuYqDRG9onVObWBRZ2m7p2sPd4FTgQyYa7fK3
Yyv1w+0m/oqwwrGfAU/Noy/tZmOXSS03k+8315mmhSCy0TpxQKCLesmRTiSLhpx6mIdjxz4jqwwv
vh39wSS7s2xEvy0UkHcqAXG762VTqmWf1CUEbo0IAyKvtDG5ylw9/U2xwQaXHlsxbi7DAnbTC/uG
Wlr9ZsrGrJa0BewrWGsxdkCiQ0FClbBHuiqDt4VEJRqA/OhZwIxvDuKiHDvyYQi1l9MFDbtcv2zN
eNTWlGmMa6cZQnOVaRW0UbNFAnoBG6l6CIaOZHE8tWVy3dmhF93VvXQwAFDQuBBtU1xiYc2raBlr
U/oWEnB06/quzWOWvVZiTpFBvRBl5tz0dg20MqhIq5jTHBBjj5EmoTQNmQ9vIY39mx4k+nhJ6GMQ
7NAPezsRsjNaMsbTBli7LIwVCTOtsSFgNcpvzdJOo2Uj/CbbiKKDhkDbEbpAXLiZc1GFIWGN6NHg
kPl6gO926vlkkPY3oBYKfu6icAei5SE3IEokuFTfGLzYn96g52rpQrOG+WZEwUOnq6wihFYTL0Am
fWstCFEkhyP0/QsFVMRZgJNJ3zpRocs3wnDSV9lYM1n1iZGvDY/fsSq9ILqyIn4fqDORRIvQqcI3
2USW3M6nRlDRWWl/CxJgZpegMYsrWgjwAuy8d/Zl63JCDk03/Aaio7dYLbUR9Kc5OfNEaRBl7XPm
JnTJqh8nltk/VUvOyQK8YID+GjKOB8ZsjPZ+4wI6w0oMwL0MpyHauq0IfgxTjaLA6NzGZn5SAti6
n3L+z4mPu2l1IJaLup4ighApVcyxW0B8OJBLW9/Y7UgPTIE+jRYwrzg9+LC4Ag6qxvSIvsdDiO5X
6nkk9emP2+Ryz1xekIokA/NHEo/Va1kptme2FsU8Y+mExXasS+fAayYwvFTOwKJXhMmjVkaCmMko
aw0EwwogXGbO4t+Qu2Qbr4RYy6iGiGpG4VAurDBywgWVgpSgCAs/+irvemqsAtLCkhiJQl8rbH4k
drdeCh41o7u8mnpXbouAQ9myqnX/ySjsJqd5osVP+MCtp9FWVUGRoomMtYJc9ELZLXBXxuAld/2Q
8STIkxDXtdTUNQA343uc5zZMgYi/BWOkvXbJ9CDhstCiV+YMM1s2MA6KhZSUELaOP5m3WtaDQvDH
EeYTW0mqK8otQRtyq6RpR8CFqGz4hbOzR/oSK9PXYxY9qYfEuKc2GYp9G5mA+kuO6XnB/EoYQKa/
mFHqPdMOzkIsWFVrsQOLnZ2SocW6UArjTxg3drqs9SR6K6JBZcAG4vTKVORSgksqdOAnQ9ETKxal
w0vddGHPRprQW4J3xwTeZgKGCsZFC+IrTyL5jb0dXLHSs4OfNtELBFL2fQtlDvaDtcXBWVI0TMmC
X7K74etqSOwBRSPDdl/lWvZWRSQN7WCD6dt4jIA6YlgfL2VH0AawO2g+CyNL1bNlBmpfgi6593oR
VrvWbM2AFC/HeDSJsHxAFFXe51mIzJaRy2Yw5cS9yX2jIJmBvKM729Xe7EqqnAZExjRKMH0bI/qJ
gO6reIC5PghPA7lVCG+4oAg9QXSAtnvFpoRgLDvqol/w+jIQXFRMSb0mGCmGbFia8okp2yTeoJqI
pWFbZnPuVDK/dyhXS4AD42RumzGh19GTIcucYUfyd56o1LhLA+nfRErv6QkwcxMpiqPsiamcpWVo
YhOqoErEw+hmBNpqIJmeKHrozlXkunmyFUBL0gUtRt/9nktQvEu4JP340rPlbxdyGJ122zaAgjbU
cZuWVgvtQLKTTZb5fgS0Aa/eV1s2GXxHRBkX46UXT7q/Nyk+kYcTirJ4zXUbBJ8+VVO7ad3APtSu
Fo8Le5jCB2lWBuiivrFS8vU68YOmK8ThAX27dmkDGn0OU8+h0AacfaGHhN6tTHco9l4kUhhn8Mr6
NXwLA/9M4fI3Qs5AS1pFcfZtECMRsP/P3nn1xs2lW/qvDPqe3zAH4JwDDMmqUkmlZEXrhpAVmNMm
uRl+/Tz055m2ym5r+lwPGg20W1bRZG3u8L5rrQfIRWO98/0N6tc8QrtEyGaqqqctM0y86T3Q4YeE
+YKU5p7YqbIVY3miWFkpTo1iSuLt2OS9fd+Q3HogZ9u+TTVzMLb0/bV3QiFmQd5+3IO7ZCh2YQnw
ddp2gzHk4QSXs6F/NLQwS1NjOPOKTigrUFfwxtRs6ohhaYZQpRqVhjj4epCWQ21SUPOU9qvUUKQi
dFTldK5rxeJczabMp1296GIKndQd4wBQiqLCS5cTyC6pg500+nx8G7LZUQJkY/VTCeig2c+lYOuw
pIN6GatafxgdLyFCzyzLF6O35yow5jbPtyaUqvhAKkd6nlVUM0Mt4iSHgZ88pq0jqasG0QBPYksx
U71CqzuyU3ed7l72ydjuOcYQ5sNtl69NozoXbCIUBb6XYcx+J3pnDAB9g2mwmIeuLIswyh1hdtJZ
AYW2AShLdG+clNVbsnv6Z2Zo4CW1iqfCMyGlICuy9X2uKeYcyEIaD0qkLCv3i8PEVnBrh4zDqu7P
c5JHoSsF+B0+sbue1Ay+ZVa2SrMj6kZc2KJVp+0EC6wMjVKfASJFuRqdNbnWHEr0GQ5M5Ljocd8v
ur7RsqIEQogIf2X+6N+mpGUdlw4RRQHEJm0Tg/7ZczIlX8GMF9WEYiLT6it7r2zjTvBicZKRPdxY
eDjISyL2K/DiljVNn2fW3EwscdDJktzyRM8JIGvLWqCU8Iw2kGSrcayw8zj3E+BaKQGN5Dfs8LiN
Yqd2urpzCtJ+Dk3NzJOnQlMP+aLpV6U3tFZgChjg/rB2ODntqAq4727IniZLnR5Vbc5hcEQT8t1a
dMBU6k5xJqLZFCsKLLk6OHXaAYfB5g9gNego8WaZ40ve6ea75y7el9katWxfKDYReQpoY05zZfSo
tsNyWWZg5P2xV61nSTSlSeSr4tZb5twJPWZWav1FIyJLXOjNtLxYUVuLUzGPRH5Hcg1qJjeX8zjr
zftoCFtu5OwB8+zLNddPh4p4U1RTZnBXqLg3YzfPiz9Z82JDlmP9OrhkbC2hHNpxDEfw0BfFgEMW
h/rIuqclCdmKaZXVKUSkKnlU2Kp/c6J46QPCPlX85URb8eobCk3CTC+TN0JyS+O2B2ikYDXqxnNE
s7M8iTy6GjtKodN7S9obW9Rqsr6Rh+Y1Yc1RzAobO/ZIQ19TtjK/QOl6WxCDlgR1Q3OKqYtMfp4t
J05uFkRrneVuwkFFTyvaD/n06hFEToJX5s3VZlAG85IDowOKRVKbYPExnVv86S52Bl2PiRmiOgqT
XeNkyzrSEvpK0mB2QS6oo+wJIyjJXiSiUjsVWjnH4OwlBXdDSYa7dFyTG027dLAiRzk48Iye89qT
ocuCBRDrVWylIrDMCmKJosnK2OgjrVrcyyXRjWTqpVddI9ZnICztfppSeiesisPzlIzzBf3j8RL2
/BztTVIDWvZbjXJBKAnwetOo5VfMP5JmyzTV52o+Q95BWNMiTJkM40UmaRedesuC6HJ2OvukLZ32
bYlIWN3oODcVf1jMpISRVda3BDCKs8SgMOXXNjlhcD0LcUNu74Aptu9nSpmKp3YnsOU765IoDpA1
5ViXnMXRE5xISK2coE3DPMN7RhpqZBCwH5RiJsvRHNTsfF4083kSjoNBINdYPwmoSsxAh2lL9PBk
dSChbdl/XZaalIDacUoOkUnqnk1EekRnumFS9xjYUKmwdOzudkUb3C0EtR88oxmTDUQTYYZW5jiX
UWLaF1naLK8wPXsz4LPa96TI7dexZdvsezyvJ8IMO7JwU0d/xkma61wymTI42YXxSBkvvskl2U8c
y1MdOhsb/47wOa+5asmXxdBVK0wuDYJ0h6mHZO9Nr8KBvaW/OZvEG5NDSUFjAK0yNKzKbAogS9ko
mgkyBAzQ7Qxb9I9iytL3P9fFfykiIbvQKU2i/EfW8ksAQpmVfaoZsnot3YyH+7REl7P7TteO6uVn
HInjXg1inQ/XWjtGPxWsIk12FiXm6nWab6BvN0Dchk96NMfl5uNLHJW457rLSupQ1atNZw4g3bVC
W1Dpr3Ihv5ocNKrhGSj3nx/hkfyfdIGj+1p7HT/dV5OzWFQxF2VSh9P4XpbulvDcxb2tVqZNxZJW
7evsW55+0Qj8+/PVP94x3cHv/TW8PNQCkRKbR8XL3mLOmlzgHJ3f+fUuDYgl28Sh8lmRdO2P/LNI
+ut1jnQWhAJKuItz9kSGe1ht49N40+6f2VWGn1lstPV5/elSR+OkRbxSGCmXQvDMTdkBOyJfDdPg
pQ1P4IT79uazoXmkhP/xHa69qDWaZBV1fvwOnZb6dzkzNt3shBRYqFv2c/c1vvOuOUnuk/qCGPvP
xF3fPSj/vNFfB87RM0VNRupBOfDyPacX6Wl+7e7tKzrwDnujA9CSmPTLt/ITBcKnVz2qG2tV46mO
w1UpXJyDA2te6hvzvH+0r9mSNFqQDrvGCfvdvzNOf73Xo4YfQNsG3jpXLQzMbYv1QgrtqQJbELiz
T/aZPZvB0Mn9n6/6S2n/6NVc356fXs3cJqYu6kfulRxFx+GFvCdWquA97UljjsxPGnwfR+7xTVKV
/3i5ekGDmUfcpD3pYVGUway+K05O5GnyyUT35xtDFvLxSqNCFVeXzNuTIi9p23ElI7BdSR2BQLt+
q3u3f36S60v3r8cqK8bHCzYVzIUOwtFrk6M74WlW6dWfr/Dn5eEXBZ5VNbFCyHD1ShHbX22jyss4
fXKN3y53KOBQpiMWQ5H78S4QwFg01rXqtdp3OzN0dsr+34Pb/BgDP13i6EFNS2f17qRXr9g2NqJ8
TbRP5411Xvjlu/jpEkfzBs5djWQx7oJSEzvbSmeWLO7bUGyWU+86vlqC5L/z9v50xaMp2cKk3oHX
qF4Td9iZ6a4dqPDvzLraFfFJpTxglPzkVfrtePvpikcruS7mTjg5V7Rx7kViG3efiSx++7L+dIWj
KZ9GDXtw+gSvqqJuTcXc2+SvR9Fp3n02466v/Z++r6MZN8JsnzrDXL1iXtqjwg5mR3CKKMJBnBOV
H6hat82qN6F9GqH222kCVSRZT6tq3zoa7zTHloZFr3p1bhBPnZb36WkNUMXPd+YNNdA8zM7BTtzM
h9n/bMfwcWPy4z346dJH7wGN0NlOdbd6ld7zMN1Rd4lHEbrGqxpfKEWyM42n/8b88dMFj94KzASV
MQuH1ZQ3zuvvydIIyGf/ZFz+IiT5vtv76TJHr8KCgMIpCfRjCtG2X66uCLwPCfn65DK/Hf4/XeVo
+GOJSoyB6vRr6QBv4RSZpts/P67PhsbR8NdnU8G2wuNqSKruN1RktTUWJpjYSH5mZ/zttPvT3Ry9
AIqZAzTTuFbtBs7WenKeCCr/DCOp/XIVdzUOoqtBeAyAzj76Ztqljk19mbRX3Z7GK4SWxENLaA6L
nS3hnKx69raPzxEAGBDOqiLgLJx/y2ByhMNk4hPJunLyS882Q1ErMtDQpKLGbtxPvlv9l/nbI37N
MlcVEJIU0gs+rkKGPjRq3rXRN1TaKI0o50x54CwOZxVaSGka9q3BIWwt08Hfho4MrEcDUSSNzrnW
Js8gOtpaqjNvjpZvOW4ctEyjMfY++52+OUVZ5UBGcj2aViuA3i9X2Y8v9cXFcm+QxR3puEq/D6d/
C315nqLc7Or3/j/WX3uhJ0w4cdL/1398+NNl81bd9OLtrT9/bo7/5odf7P7r+4/jt3pFSn74w6bq
aQ5eD29i/vLWDcXfF/nxN/9ff/g/3r5/yu3cvP3nP17qoerXT0PnWf3jx4/2rwAo113C//x+Ez8+
/8cPL55Lfu+q/oVruf7C31xL3fwL2wSSK/xwpK4Yq0HtB9aSn6yiJL45fuqQrvZ/sZaW+deayQPW
DFEvCSWrwaWDgZr85z9M7681XYPMORV5nstf+reglh8XJhYFB98mySf0Sciww7bzcSCqzqIJ+C0A
OAirAhq0QGTYZlpcUZOq7V7SSCVGl4aUCQU7WuyNSHVr2umDLtzwp4fGM5rjuvqZCfhx9/f9n2KA
6+SVQtCCXP5oOpJmO9KFUlUwAoKQ/sKJNoMQtFRi/ZPX77MrHU1GxBBSw290RMMTkCwReylqH5Fd
slqpmz/f1NFi8fddsc1cJXckVeH//PiAdbo1iDA0FQFxL3d5Da+CanYdein+SwAyQzibyJxsfbZI
lB/J6sfd9Pznf8Tv7vfnf8PRk13MocsQBqpB4iTppYEUKIzQp32ZNKAUf77U+lH/3Oj8uF2TqVdb
TajkV328XWuW5RhRwApcgO8HXM61xqEkV3TWfs9OAg1Y2Pz3xMOUwdv2m4Hzu2vi3l01lUTO6O7R
7VnKkiPV5PYyvkUwA6k+7Jy+1h6VXNXpgKbLyZ9v8ntO5fFdglak4AKRjHfo6K0BZjJXeB1Qqumy
fqD4OhziZMBr2skRDWdtTGhm2YhABrVc4YUmRjh1L2bhyqcZWbxNFDvW8A0sN1rLdVUtFIsaVFew
xJWrylbj5hIYAqIEZQ2IuHIIXHaCP9/E7wbFukdDe4np6PsU9/PBGARILV3X0ALHpEPiC4AsO68o
ES0YxlB//fPFcLf/OjAwvFNjJdmR5Nxj7TStVQ/8uAtAaulJlfcGBx3+SkW5Xg9qjm8MCTADGjFK
EYyx7mDzaqmj9o3V0GRfIhvKhlKjS2mmLmGnkvTNgSaV7YSj04ORGKzK6E8k+RFV2Ap0h0G29NPt
nKCk9Hnu9Z2cnKm8QzSRJjSGhhKFjNVXru/EJrkKES7Md72pbFi9mltdVUmZTyEHRVlZtAGzOaQw
rVCZaVAknhBdK+qQjDsJ9gF8SnolascciXd1xySoBNEjAancyxPwsabYlpmpW+eCmH/oWn2s3AhL
mt+G0kqabWRUixV2eUQKirH2UdSoAWwCI9B90WIinX2Td4YymNu6X7TJlTvhkPro91pHCj3/7Qe0
Gkk/AC4aFfqhg5Y/9mrrXQ1sK3oycMzmjqhLFcGPlPU1afZWSRt3qB2/pN955/Vk8wVWSpfbAdb0
lceE/MYl/fEVNa8zr82kVIAUW+HaZGZbb6MJUsYfKWXm9AiL7sU2Z+cBHYj9SPIB9glskvZpQ2vo
pdMzmFRQroxHK6+WCwEx4U2b9fFagvHRSWSJ8qfccGsATtUCRaTDjXZN6oGehKg3rPsZPQb7ntqe
bzAfYeRullq9WRQljjduVMsbN2/cLwvEkoqTsI4qbMrc3qRRUywnDXmUoFIKMB4+4dWL589uR2eq
Eg4CHIWuSE1mr3Re7GqKst2SK+l7n5lIUzKgVweTiiAhNQWSz3CZVUfCiwO712Yp2tmSefELy6VT
bGw91Z3Br4lSWu4ReKtyZ6MptE+TqjbNU+g0etT5S4nscUfGQXYHWlh3EDSZ9PqrbMzpTdWOuOsw
KBloNz2zOSGgzrT2RI/YNT3hDv0pYiMURJAurcEg4rpNvAS9IsKXC3pKqOuwFceRbwrLNqg6tNN1
rKoYXDoWGRTXqxYfmYphT2E51QUiXyBvm0VgoPZFoma8kpA0UW6kQwsIR4HJ1UvHgspCDDKvCu0b
z89oUd0Zi+Qk7hlELQasaZwel3TJgVjYTvdcIKvXDq1JcjId/Qo+3ZKNRSA9XbmIsYpbJ0jyCJVG
3mSP5/nSCDus9EYfd6bEtr91y6a3QyxEDAXqg/jdfLQjXnVmjZaV3dUtrly/V+RghpW9tN5uzid3
Po+ceSTzUQzz/DCx35GbqmmtdttU/TS9rca1Ce5Fwn8orY6Q6WYdYNY3nZfMDDzaKxe1SR32HvxV
Ii/1Xs+TSxWyJw0/XpQzM4awEaZRPKjXTasYD5baR66/2HMtdtFYKGjhGJ0JUsGmLMMKOavmcxwX
qLqr2ntQm7mx91mLIMB3Kgu2hE6e3bKfJtGjl3QyRrAdTeQDOIl5U2k6sgF9xB0VKJRqzyW+HrDU
udqCR8LSncH+Qyd+YseFNW+kpjKDMGlCWX2wFCO5cpp4/IbqeJGPUdmkDscC9OLtU23bgt4rSUg5
wSaJjq65g8korPIsMiISrms7taUTSNnbFeAa0eqNRuuClK/LMleG2Qrp6BVxwZ4pJQp5j0dflWEa
p/Yt2lMAot4Ejmz1FwGqMRJbH0FsgfncjWbDIBx0S6lDcMGDG4za1N+2eFWTkzLTkLUUqit7GtJ8
sm86U/4AUZXmlzY3bk0DZ7DtrTSGeEcrPS/Pza7JCQ6f+66+GSDeoXHKKvs+pyN4SwSCd1A0kZyz
DC2DP+Va5PiEecdntRimbZLbCRF8Rh5MKgfdZJHNXVcb0Y2ZTIiM4lZa4bhoKHOKqayeo6SI0De2
6LbgcX/pkA7fJYjsDhJlXmiPrryPFDQhLiFqYeSwRda7fjMq03mB5OQiy4pn0sHpX7aRLTbVGvjd
gbjzUfOkm45koa2pjzQ6oCFyDFdA1aLlLG67VEoVTbemns1xt2lzF+F005KIloE6tuPQNEBJ+kPS
Wyd0VVOy7z3vEUWy4i9OfC0bU09PSsM95J4XofztHTyhSggMFxb6UBngYtWniE3ZRi9GcQeVsof5
JMYTVEPy2ZIE4jCZSFZck3opAhRCfs1Edts0L5JtrzYnkdM+AEcEWEar2X3uys4FzlaUJxyzhn2O
vPirN+nTyVibcleu2WgQ1N2dR/QXYgttmTeNOb1UXv2Q51FxIupkMxvUpCSizyB3I9lsHWvKzrMJ
2mVKYM5Z3jWGGmYawqfR1MD/jHBASWPjHO2NsHmV6CSv9Bd3bKw8UErtqc0XbDYzrkeny/LdUBKM
4tcZ0usmqh+iabQfom5pbg3mt4CNpHuNCMzYQEPGdOUM71kCo0fxkrOua18mJxJIeYvrusKjiMZ5
p+jZA9a3q5Gow11Rsh7n67NCbdBv4tzUw0XMwwoSQoevFZXcR4lQtynEqC7VbvXCMJHSo4nyqrbd
jlnnnGSoWU9nSELg91ojSMFv0lBUcUmu8UWPCJx6bMsinndapRsXmVtRFSApNguFPuaDL6Re+DJv
n9APJDeVDmsOjlaPn1VEk6tvHFyDhT3b276V0Z496+1q3rsYU4u1BWjdJeElpyL1TsoGnKzb1d+S
Ub/IwDkhUlEQ4Gnd3qXDcFrHzmVq1mPgDd0h0am0AX1SAqtaJ5AxoU8YstE9EOycvK8Bld+cBXJI
6S1o721vClTFXM4y8G42n6DP1OkIqWEjCHoTiReEZYoZvFo6EWkyIjvfjDYkXu8njY2ANRqXQ+a8
qXjyVysoFNEuA5CpvsNI2rId6y8bRe3RQbk7qRtd0KBfxKYgQnNBjioM8zIZY/mIhkDZm0tyneOp
Q4+YDWhu9VQJ1Uaprxfwu74mpipEQb6l8CK2ZeUQbGHCq+qIKYA/SgTtEkxjhypQ6Tfs+6J9aqHJ
rAsaMWk1X9dog7aJUz7FnXRvjEo7zd1mDMDK7srEyUF/uecR1NreaZ5NT3JcUbobRWb73puDLk4e
eyO6nQf8hbIVZ02t6gCp4megwyPaTBctaot7rFA2dkpyQtW1yVlD/KESsb8hMvClaxfpt+NadWs1
dZfkbIyRErucS6YsKOYyBYGq85cBbka7OMuoLM0wtx/r2elDdZ7f1YJyVFLNISatBV/Ft6YEWaZH
ehV2dorApgFN5MxPppoMm8QeiMD3+oPhkhqezPW5ydYXoUYa0zMCbXrnTmlqb3r4eLtKGHIKVXsE
gVS3tmRjIvArDDF65cDC0b+EPbvEx9iKDT7MTOZvOiq/xp/6Ob7mWWdu4OaCWW5QluvUjuKbOZ2q
B3JdUa6i+2l5amVcokw1Ejf3CTRX35wepY+f2YCXA40x1wZFais5Z++yhxaJh2bfV8VohexEbAq8
Sae7vqVYy/Dotc6S7tTUar19szj9RSbnyNxqkVlf5XCVI4TVnnFSqoDj0CnbnOmIqUcLLPRpr+aF
d6JMToJzexkyRk5X5ejUvcT4FiOBLtDrFV26yQxDvPMYC4fFoFLDjsSGVzG7Gh6waCD9Jm9BhkOJ
NcdkS8qC8+RRuqT/U82W3Dc0vC46Cjo8RkWNbjM4WeiPEkf/AqgYDLmhaNmFCpAwDwVhkM/aiALx
JqLgpDOorQ7CHYxm9AqplUWbRuitC0hG7cdwQdw0+Lq11Ogs0exi5kUqds8h96ah0O4GHpUa0Glj
W+TosxKYdxxj+d/SlJ7mN1JJ3ptI03N/6FCnhU2nNP0urlu1JbFJSfeIUOqnVcW4Ga1Iv+89i+jP
bFC6B1SpQoTTXPGUHF1Qmxo9dOQ4yWP7kBZGj+JMl4L/O6kEI106RO1Y2lDe2w545jRGyBtoGI1u
NXdiGXP7lVNMZh9R8HhGxFPXdBnPCuUfYeXK0AbN7FRXCfIdc4NvJGFtiCGYowvqiycnQyLpo7Fs
TjS9mId9r5vtW6Q76VM5VvIaP+L45NZmuy+GZjYY21VrbGDNWw+9iNjvFVW77HLyyXu21YszBc1I
XQw/uYd/P10G7RtCLO8BhhvzUUHaCfNursRLSHPDvkMaR+6CYGBKvzCK8YvptPVrLkvs6TCWoyIY
4G0dwIhTSjMXQW5/PZhWu/G8zqx2BKXWbwJl3xMuHuvWsMsG1Qie1TrAaIjNKXc9MYQOWdFMXGi0
Gl7Fany12TKIYIFq2mEukNoXs3D66zgCNHvacZEvkK9lh5YzUuTOtPqc5RLvJQDsbkCYbrjLt6i0
6utZiXF9tVZc3Ee13r7IQl0uc7q1QBUUq7EYC3F7W2Y6+Qe9nVgr0RpYdGgRtUoRaQB05wN/Jnmq
B9huhF5kmU92Fbkz962nL0qHjZYVNwLwyA11DQWgPn0HZmtcD2jcWWRwC3QhW4Tl0V3qtmOZcSpO
0r2cq12nN8XdxPbd8bWqrF6VAUcOE7Fov8gCQw8Y1QrtnctMG2+KolJf2wiETBDN6ugEnR7b5gbo
Y71sJrSSJI4u44wk2JrnQ2pIZQwba1K+FtIVmq8tSlMHoqCu6ksUrPl2ypUJZyhuNh5yP3N8siKh
5JuEBGwR9IWLSl0SqA3GNSMTy9AL64tRLpmLxrnV7xDtmXxs5w6cyfom0XxPNUowtbZatRtFF80e
z94cb+c+1nDl9La2L0Hzats8yfppu4AC7Xe51L353CooR/se8gmQkV4Jvz4zk2uHDaqGe2MU9cZa
RpQUbeuKHPNIWcWUGtYzkCLy5c01uiHZEedLZC/lFeWLm6hrbmbnAAQg2tHJt1Yjxjswk/hfwUUK
ha101V4jNEUnhzg+705ACDnEmcRGcS36iZxi4K5qtIEliomrT+gQb2Te96SQEG2A92q1FKi93C6l
N8XB2NjuQ5RatQSbxAq1jQu6HlvcSfm/X1/lNM5GiaM1kS/WUTmwUsua0hL15JnX2XeZUaBL2upO
qarxkyL5b2qdZBTqWJpXU7VrHZWupZ3lC5hwNZjEvGzb0iCnMMPNpPU24CSMi5/Ur39TJVxvCue2
QSuC7trHeq4zdIVqrfVc3RFM7lEynTEEeCkVZfqkjPvLpWhmUVAigApgxGoY/3gpw0DUnyQFl4pd
FF8q6xtZbVNgLJr1WT/+Y/+NMjV5teSiOyTZrAGCx25tG2tvExllEiJvVr8sVpPtS+p1JXNdPW4U
fPoOaFtPZ3vpqhnQJ6erL5pJibeD1JXbjIP/ebfiObd/rpP+8vXy7/IINbNIiiNhwj4aSalndXme
xwk+hfmrTLOBAxWgdNSh6YYNtPqJGOY3l4MIQqke0ssaZ330yPO4FfYw2WnoWQC+9WjWQkld6IS+
47trecYn3/DHhvP3p05rQHPX0EQkfN8jw3/SYpl6hUtatehuLknUPYO6Fu59SQ7AxkwSZX7SUTvT
arOLcrNYvf13Dfr/9yf/wej+193J//UeJ88V4bHPH3qa/M7fDUqHXiOh8zSjDQYAqmgq9383KG31
L2BM2Mpppps0qtfWJei8tQtpuH+R7GJjOl+HwTor/GhP6t5fTBTgRHivjL9/9H/6pj86ObR0/2Vn
hyG/jvh/tloIqNeZVum1gKygWUFy+MdZAX+AClhPiTYaTJGDYrhvc8Kyry7jgUK+HRTWeNoCmT6l
FhyfKjL5mpuZunWlFaj6jK1EiPqc/UJZ+F1kWwQK0a3hjEFkUVBHKme5gQ7NFdWrKKZ9k0L/Hft4
LK7yzOrkpk3YOql8Sqs7ucBxh/37hV2FKV5ReE9nyzR0ykPj6XX8ABe+fJS9I8970/nmDNpwXVSl
qvqa11GGdpOStDFbzdlS2t6+tT3aHfCoSZqK3evEnHFB+DVW1+Z8BEVMxXissfIXYEb7g+diaIE/
WwYDHcUQLeVw2riW9DtRaKeS8n9gteMU9Ep65Sx4P6yI/aGatkSLcOtKa5wl0fDEBrIOh9LUiYGa
UnFqyvLQWVVacKDQnLCYahxOurB3drXQZCE2LemMM8gh2a6g/NhtJdJqgNUo1SnKeRWCERlZSCqX
zuccHnYrdUeLCTdh2z837JaM8qDZxIO1dTlRlvZCNk6FfQl7gN1Aqb3jrT7Pym68wY9zQf22iy+a
cpxL31IdcS8EWyCzz847PhKe92LnVB3dnOvOapJc6rmeUhkvkvKtI77PCto2b8at0BOOHFPCHmE1
8ckhSDrrXhHC7aiTMm8HBmh5wieioNL10d3W1BDH+xlGys3gGf2ZSMb7lip/znaU7DqtUbPtoJrN
mcVju1KzZs9BNIxlc1VXROzOWovak1UtjIW9ReX+nNf4UCytU3eQienuenm3TYpB7KQ3smEpNA6l
rqVdVs6A9TPX69H2G4aMPB17K7nCxoFtQcFbPe6bpJjvnE7T7JBC1kVnOSdRn1GAGZdk68SxSTLQ
UjQRGOcF13I+IDdffT1+lrnjeRQVe9Hn/epWrsfmmirVkpyyN0xLpFgu6W1WwcKLD8JwIa0qqq8S
1OQjhrH81l6wFeudk+4oQO+HaYyePF3GBKR1xBSIAZvgYk0bXussmEx1uSFDrITcQKxpOBTDrRYt
zmVGWlZO2V2vX0keSbcdsZp0ryrz0nAxaERVFWiNfTYu8RD2jatuK3OiSJPOT6ks3ysj3TVafRo3
/YF4iLDMPXDwxrTF3ko3RHgHR0uje07DVImGjFRlit+jb1V93vEepQ29HKyO/a6Wk1K+6bxMW8b0
PJ0OedZMHMbzU9uqKqrCVXVjAidIMZcMw/kyNR5GGaae/LSW7XRFAwW1JcVRd/bJ8QU4kuLG8afY
xI23ZB1EKLX8QmsJM75UDzZdjcqPGmU+he59FuEpP6sNzg1r8b6o/WSw0RpRb7eMLRVSJ5g7oy22
S113OzftZRWkyIGK3ZQt4lltsaXs8G90ZbB0k6FvzHSyTgeq69fqUFDF7jrRnMdsFigFqHN1RaWE
U0AzNdiYe7L8vslYA9rqCFzRfuHUjkWgBJ6g2HSBWZbxO3Qw+OKCknZZQlJfxtymGBonBjknxbs3
mtlj4Q1DtJNpIik7D2jsFNp564Y3nzZKlaRfokk+e1PunbbkmYVdoXHSy6l4rObEW8rG46mjyG41
1Bm7Mo0FpVx3JAuiTat8o8y9IEK19tQTbDNP5qJ0px7olTOnmcnJc/K4HwkzL7JdT/QEsWWiNcZt
axUeU18P6hkDGae9BuEwzubnvmhwzXc9p5017g6X9KauJTvzBX/QmdKIQWwV5KWo9+yYcjx4Eaqa
g1NeZATNPGbQ9rRAeN0uHxIRjrRAT+zavTVcDjbhZN0qNr4oBPpxGZArIu5Qnl0W5JJwFHNPbGoE
AH8nd+d4xiPzq6Di68iDZ1FOVyVnm3huzh3MiFQ/CoICMSU26oT5XfRx5IakuvdbMdlkCnSWDunW
Gg7J4oB6VsZLy0tawt7wS3acOMh/RobgmfZJQ2XtOlfK5pQUg+qrzLPkbhlosfitrn8lyfV6UAR0
3KQZfZyqd4xy16f7eU1gFvoxzby2yWpR/SVpz4ljecvm/FV3RkrpjqK6eKsi9aLIIEb5Xsy2mekb
k2qgl2Kg+9Qa1Unmml9YotzTtKJ8JWJzOm/VprytSr0S9C/LjaGo7aHRvJlhXFSsOpwE6WKSLPBc
NxTX+xJ7pDaEVsMxv1+zbPy07E4p89PGpZ63sTVUgyKXMmyEwLmpmHEl/UZZ8Fxi1t+UXib8qBsP
tW6cq1PzJerJmN2OlD6YYakRRg9thRktxCNHKaqyvW2koGFeLC8AJxSfUO3M8Q2Rp/e04L677VNX
2ae9Xl0urV4rpGpwOPBtkYoUn4RXLIEtqtsIhQBfZLIwa3pwgetrRVsIIVeN3AiiuO2y04Rl7Hnu
6Q8GJaY0gYjamW/0jAwFP81I2KX0PLxIhxd3a5JnXQWu3ar3C0kTp0ZlV5vZythpSM0ANtOnZLFQ
ByCiMaKlSWS9Tr7lYUrjbGOMyYHIf8UjcQHHYJZZFWZKp+u/5g4ymUCleOduaauXV/Y8GOYGbUpx
TuCh3Z+hQ57oeU7NwUN98dWJc6Efpk6/0ESeXXVFvcuGCs1wUb1UGYYcKY2C2J28zQO9avvbJc3V
yUedebCjusSzwxYx32BwX3y7zP43e+exIzuSZulXGcyeDWqxdafTdWh5N0RcRU2aGYWRfPr+PGsG
nZXdXYmZ2c4mgUJlhkc4SeMvzvlOtq/KoDzZpHW8OCPLIHZmDYwlu26TkldlK6a5uMjceSpSG2gP
t0ku8f020UNucnGSIqVc3aS1rpmZgqrcsK34g9IrFJMzt09ZWYg079hyNfwdle2Chwbh5Ij9MPvj
uKWbc4etZeZt9pINS/CLpcxjiuat2drOECyYJqmsYq4gFud1WUT35grWqdsSg7FKoiYMvuxCm1cB
P7Nh5d7q9C4nv1ltC8JeiciEB4hJcGQNu8GemvqHUgFO2CASMXSC06WX+8k19O8SMWzFAWq8FQ3i
B9ZE9YHZlZ34FChQYoZ2cpLe6/z7yeahRbQZ4zbENt514akvxZAU3fROw6wSYdnohDhM83FrRTJF
W8bkaL5toqvZrzZ1CRcAqUx5IyR14n3GhY0C3TdnK2ap9MBE5NJ29pIADUrPKZqmxEhDI4/bcMQJ
vyIhNeMsb0yAOnhQt3laLDBtUImw01TrevTDrjjpMreNbZjKwzDaOvFMHnmrqH/VBRitsnLsu8JU
wTUlDUBuV1aa3cYApHxn8ir9zg5KIT6s+6vZgCb2YZWXgSgfcwR6PQ/Ckp1uTlGvsuw9V5mi3Wnc
6+J4zJhG5DSzWWTxFBT9qTAANpWlemUUpxDdVfkPaDoHs2ra2Jz7/i3QwHI3E0y672SM6MMYdtZv
LqwgIKf095E2EE70iJNQ9aAO0l36PggM25XhRN8kS5SJsWhfnLJJh/qVkzscTwMwoNPiKb3rGh2+
5ryn2cKZovfjsmIXP5E//MrapSGDVE9bv3OGfTox2t1kwjFIvaLtzZ2qwha9oGCze0v8WLvWKndE
y//2HKoY4mXliR086z7CxwuxXzGO1pfRCTgpS5n5K7bcsv5Y56nBYRVMywnphVvvWz2u0RHpkrED
UmDJWKxQeqGrjdWL5a9wOxacs/U+tPGhbbW2erTF9exnV5yvnnfNPXfMdl3VFs5BlVm7myIH6ujS
Shfgj8rkvC0Xjivm6ciUU43ABuN5NjnPxLNzaARW0/5qORgtSu9IO6ADiMADFxsN9rKHVi2wmwNf
ag1ez1sj1WVsh7P/vZya6aHOl8xNck3Bp3fIDEpYXxkG7vU5mnpPfFM1OJmNK9WRg0AzAY+kGL/W
drCsAzunpbr0awHpBZv8DeM0bAKF/umxJjD4ZxXkLPhqCfdwwx7Hexlcr6CuHAPQWQIqkh0vQLAa
6bpQpgjIQg9gZirdGV39zGUNIC1Bg2DS26w1YbjjUizzLlVD/1PmZjQmWov7SIt94OTNq4md5YPh
SIcwDAbru2dPHOylAl/Ka6JX9wLq1zllXvm9aYEckDg8uJ/o4dqB8S829AQQUTskDeo3XNLqJjjj
IXby6KsAO59tqYcf5xWVAnUcoFt4V1GNM9/Loo3TVmj68cGBgskjY/IgmpUseWB6FUZChCc0Nsvk
0u9NXbHI5aVKautQldmhW5EMbe118INE6hKWUztG/jYzdOUmrPQt/9s89dLdEbtQo4UTg4saovFZ
OtYsmXaL3WKGhzbiPTYEp8kkz+ZivBR5VhFVAcgY7i8ZCdu2aZrfgAr8OulIJX2lgFFq27vTrUrK
qkOL0+0ubbLuO7AUdrhgDc13n50AbdaUo/cw3YotXCS8el+UaUsR53QJultnStLS68qrR6MWHUs2
2Lz3e+GbH1GEQGMjLGFc6yLzD1M3pXeK0Gfs5XnRvbZZvhTJkg3TY51aw3dF6i/yMyf93bdySipr
8TcQPsyWuwWEYFwr4dzXwO0E1AvZZfwzEPnGzzNWbjPavicPAOk2s7zV2YjVQzqTduYQ7oYibcsr
2PsC6RUv6XIj8x4kU0oyPdCQycIhnsOOyXZYGd00GeUyvs9CqCfW6SO7KDhaB2fiDPjoIlYfJ7yW
GkOREdZdDD+WCPrSs6+BsbpPbjWd6syESSMoajY+iN4HFnnIDJZ0Gft97lEUQPeoq/lKBGrGluK2
X7P6tni/KSqbUzQVRnXsCXin5s2XNa5Y7GYXxq30QFrNDsw/DeR+Qf1Q5M9hvXRLPEuSje8dlyyW
jbS0r4/GZAYAR+1ODFeQhH730Gclix6DUFR1Gmm2fmQtFD92E2aKRKbgTdZrMXxGblqxERsN/4zU
z96V3K1U6oSiPy553fOSComposZ88hW91RiaRZy6BFeX5Kzd2UHpHxnE9A+qruQmNBA6QdZoPwLE
RRcqkPAY0a48K8vJv9XZ7FIz1OzZHXp0XqVOCuljQlGHQrIbWEOE9qzjym7sC1hykyqn6dADtv3J
jJYVhQTXIZ+LuyEHjBUZikvOcRDPbbrkd6C13eFgW4a1PNeidn/nDrCNcyUnRDRRaVSHrJABEIt0
mixarhZ6SItwrn0ISXOOQIN3cMIB/wVzG303HN2YFeeqrL5NRC5elOS5u4f/4DUHXRhRNKLlGg9u
Gu5MR6cxQ6znUnTPZsiljTx2Xan5rsGMbXJLvsxs9jemoR5ajx9l1o/azA5NCOwzJPj8fqTcexZU
2tCOvGsqmoMXhgZLmOyNZGDYk95JTs13alZYt/Ix6sWTsq1fjVVe7BHmSVU2u66fv2xISLEbDMcs
XZ+isoaLdmM5E6Qdm4H3ThJDBkyhe1Bh9xhazaen3GcCP+517XqXDgExEzVSX/y8u2/m/p7BzVlH
3GQQS768rvskY9aMw6DwEpAGIGhmawDs5v2QfmX/rK2apmBASDmo7Gsmy7lrq4sRCSY0N9d+zXLW
Y/a+GaJeMjOybzfMAG6Sjpo9G6j4ximRyhQv5E1KxjAUndztvzRgpI012U952b2pnobI69cNDMMb
Nyotb8iRXh2hWIr1YJZmB0gw7BAdvEatwDPaCuwJbLV85Wav1erInbmqC+/nu3Qh3wTpJbLedb5H
iHDIV/+Jmc61s9oj6pddWDL2qD3OLYuWwlvQ260VumSzP2pjcuLULpPAnM9G3945lPBpRX7Y6k8G
AV7+FljuRftGc21FaVIYdPfmVFOW+MNnPTtrgtpiTCpZREcbVRZyP3FPvdVvDUYCudfqXYNlbWcO
w2u0BA/Kirp74WQXUIAvoFR8wOvRLF9JYfxtE0tz4WALT3qiy2VmI89GJdc7y5/vKLXsDUSPA2tS
xmjENZR++ouUI+B66foFgvfzplLYIc09doVRXPoue5jmbq9n+24aFvfJqX0EMt6iNsIcoxMwFnHs
O6M9uAiUNj4bd1bccIJoe8TZ7mVxBLz4EeVGIgS/IG9/OF8IeKlWtyk4G4wLwX6u6ztlefPRz8un
zuuDmB4y5eaTxaUzvN7ZObdrTnYxYt/pezqjQ7Zd+kB4afDrMZLFcI9SBMnzcAzc9t4yyue1qZki
TWK5j6pp+d674dHP0rfRWb8V3XhqMO7snWq5Z5ggN07nPFkU7+YqisMylcW+aen4hOUdShY8l9xy
+83SkJRg9myfIeuv995si4MOxL7ommnDa4jbidN7W9tN/8zHCKjLPB63fvoQKOtL1hS/xAYiNREi
gK3WmAe/txSjZvva2npEI4bmbxTVi/KbJ3Qin2OYQ/7nDU61wVzATH/dUn8rpKt+Q2GaFsXA9wrW
phyjx56MnhPxFC3VSJ2rqKaP7nc6wOLY5473kS1goxiA3A95+A1Z6hlS27cumPQODxVCpYhZdx1l
miW889kbjdpmxXoHH4sb1uovZCMM36J8qnauWxxl7Z5MAtDQIlVDdN9kAbIG2m2b5DXp5sahHxHR
HhjzMydtPT9rfzitLeufKgILuuZVdCkECpm+g08nRW4/qjx0Xvy1XC8T66ytEuY7HHN29B7yGqx6
RpwtRplvgSXpg0Yd/z57XP12WoJdUKggGe0BFWmarydHpA2P52wkrOg8RO5miimAeUbflxSSbb/N
S8GbZprlc5laTaJAyWzDJj8HWldH8p2thBQHRMGC2VuJs7fqXsJmfXQC5yWjzN/IUQbnSTXLoVzG
Q01Barv2nmruSq6C2pINkcZ5UUxQEtEE+jdVGb3Di1UNklUo7qC2sK2zpEg5oIfaMZA88+D6m4rB
3MZZ5bsy1/JY9UVzaIZspXPBaDmJoNlZuG7QHhBlzHCiqQoEe+brIv2D2QsRu0zPzlUu5C8DAcwh
G4lEGeid4lC5l6LtPQIn52MbjUcdzKe+adLnTIzLJctKS8VB5RwznwYydar+Q3gtE8O1vLMd9JPY
Nq6oYgZUuFN1KVAyfxay/uGGK/4q0uU3QTi8rpbOX26urDiXokp0COm4nNU+y/sXFTTtNlc27KZ2
I4pJMiZv2ne7IBByHrvvmZF9F30bI3TRSePNQxzV+nfFQ9JVbNgggXZNUpDPyIXdVXSTqDRaOlJ+
amVPPEpjnyV15sKI1gEaFVP9LLXxLViGh1pZe0Qw/bFw6580OLzgDXNvy+YwhPnHHMILs5ZX4Iw0
0Nn46oNb/cwQwSTce/zyYZ+122iqrpCkv6+h9n5qb93nM17bon0f+UJxbPE7S2nv50Uc8eQe5yq9
Tun6yzanfNtI3YQxuvOghaA5Zkf2YQAxRyKaTWbmblLIqkvkTOypR65sFrNcS08jx9SbY44f5eAN
O1wqb0FaftKd/HbW8b6aC3QK9nBHXYgcz0GIlI04EZiNxG3OwIaf+Rz6Aw1PyqWDavrluhxAYymD
B4lMRHbudXLCgWmCBUWehALL36QmFqskC4fJZZyeUfTB9W0hJcGSdhXtbTH7AwdLhXSFcVtwrxHT
bURIt2D3IMkjtG+7eTD2DGCCXZZH3Ucddv414ir/9EyW05bhfZhrr/too4Il5Kmuy/4e7LRhsG/0
UuiljRndUXG1MG2nNLWPqavmZic0XwFalFS9zTJjhFFC5FwyfZqyFnnTGgbrK0qIBbJjrS1Iw5nh
Ew001yIiBNupp+5+YqiQ8R17a4PLwO26oXyaVjl7uxHQVpnQSen8qTFsD9XgwLYG6V94Uhwdvysm
+Fdz1OUv2x+ycTNoq5hfvaqeTE6EoD2E0ulPlVp1vRktPXvVlb8uyO9z6RbeqWZAmzSMtm52g8HZ
MzRbuAurNhZZ4W3TIvy2NM21coFi45LmRYqcJxLod7vSrDfK6xKbiLKEXEmG7pPsxZ0RetcmbY0f
Bffag9UvzLIY7yjitpJIp0yaB15rq3lqhz5NrMz4yXFzR9zKDoEZxqgbU4uJ9BxPHc6qNC1dBghR
tSunwf7p2TqPeXTceO5k9yHpbNgCQchOy7zbdFmHSSMK98JpBPU3d9ggEhBYmcfGRHkG4yW0luZq
lBfI5XDJaDYJt6GmcLKkKkHuguyaiMG5yTUdbDpA8c2tF1RrMjIVzRLhTumHWCtM5EbrgoGbvNna
4PnwkQfX29BN/6H/+f8ihv/Ji+dfyRhe22L49fN/nOFo/eyaP7uz//gP/6FlsP6NgCoUCbjrTYKw
kND8by2DEf6bD90M/2HA9Nm3wwghwf8SM6BzYE6ME9JznMjBlo+o6j/c1ggfAjN0UW3+IXT4i3rh
X6kZ/mKBRGXEj7ARu4NbI8zHu4mS/iR/ARU7MH1myV8DgTR5E6jsb4yp/+UnOKhzsBOi54hu//+f
PqHvK6lGSAuMZTeKiBozK/8fP+EviqFIjJpniU9o5Ba+6yEY+v+bT3BNDIm2HdrBXxVu1pr1fmng
ohiD2PDcgyzV33zCH6b2/9CUhLaFxRzNC0okrrbt/WHv/dPXRBZoDrqWxUk9gGG/5sAYnte+Cd8L
AFXW2VRStPxl2UCGVNheW7dId7YI6mtI/IO7zeVqledZ4ltFGWou64eyQPYdJDFN1v7G/Z4vpmGW
DelAFUvIP932f+t25pfnxsE/y6KDsMAQcc4/X2PZVbP0JWjnaLUu5vAzjKoTNGiyfN2/+aTbtfyn
r4lPuunwHNMlX/Y/CfIMDIW5WaP3tBfxkoaqPE/B+ogxdv3Hofbfynz+6w9yIt9HjeZwzf/5T2IT
6DdFm9sbd/Rj0jO2RMi/FZH++D/95gLbuwUvI2rycOL/5fmb/boLF7ynG9NHQUP0BUrs8HNu/QPT
zL/5rJsO85+/OyoI+A23f5Dr6Pzls4qgGlyzQPw6htSxZSLLjo3MipjinAd/Ixr8S4rm7ZYIbno6
J7LQXlnmHzi9P93Pld/SNc54BmeiXmr/zSQoNDhHhMzI8CuYnlR2CpuLQ5X0r79QK7qJw/76dyLn
IxfwDyc8a5p/vnT4+lQmMHKwYvbGl8CamCYs9HSIq8Ixu281YFFiD+vgp42z+wQjcX1y9NTthn6W
LrUag9ZD7S7FfYkm095WvkBCjKcsZ3DqjcaH0E29R5husqGzjfZcWqN4XSKbuwWvxvACRN/6TNc+
+kbIAfqMPmwkbFRPUqFhqxjlxmhGthaF42vg7NlNHlAii76UYh2OXdjyb0tfT99rcTMPBZmNKFmE
MO6VtPxd7fXhkzc2un/KBlp24hJo6E+NSQV6zhgjfB9obB/qChvZxqBbHbfMT9aTKYLeJeIkKp6Y
K/7i1YCEAW3XiOl9jgDKZKyC1xjWsvWs8dHY5zEUtn9CuCyf5Yq++jgLTyWLMPqfBTPoB6/Nu2Nj
5+2hCXBgukNjEVFQwgeIe8GOcD+NvnN1XI00RzY3im8ehDSt4dQZLgoCQmYTkLQC3I2BKWUdV1HG
w1I18z0zpz4WKY3GFf7q9JUiID/LTDq0R9J8jJw+fLCU3UE8df1LuDJ0Mya/cLdZM95CBD2zu7ej
bmqSaRrM8Tmba2R0pZS9vfFZhs/X3ugzfaZnm2BfEQ8x+9uyZ4G77+18JJajCoIFIXOnn0UbZPkW
fHP1Ga3RqeS8O3jEbSd5qBxSYPvoWbcc33srSxMGX4ASyQvjtnOCNwR06QUbpBy2Tco0VxRVq5HJ
zXbSy2CO6aCmE8YI1GWmymYs06JsXxDEODtDVv6ctAhz3cvIIKZjG58HHoE4ut6voW+Q64NPFG4B
swpU2KPLXe2r/KHCF75lvy9D2mcA7Bh0O3Udh2ndwasuK2TEqjjat6300zgsJruBdInGc8NXeR/l
oTzqNOLl0baLXl4q7h1nr/lxxD/kVlONAxsq4jhZTiFgGe1sPauh9WMIyXrB9tZxL28KuwuTbOlA
zwd1oZN+wJV+knrKy70nJ4wTsI9t075nu9OXPybShsmCJ8LcOCwe3eszYd/lF+MxeEH0VcGxJrUL
kkDU1f52aSLvxa9aVVxg5dN0E07WeLH0VflNrgOb6Bi+CN3cxAt97wYLC0FsBDVGMkuBQ26V6Y9x
11nqva2AESSF3evYSZ0BodcSPedugxcA6DqcT9MevuzazYGxjfpgLFo9zMCePnPXFb9tS7sHDE02
8xsjZK+uxq9QmnrnZQVdBfmV4RRbbs2QvCjkzXQyphMW4dB47aG82ZuW+XiwwX2c/+zGKHxKUzYZ
W0O367tCfU4YgKhX6LCl3W291GyTQE/eCUfIzbnKqZtMfQokEy/Z10L0EnabeXT2Btu2h2ks+T0M
4kQ2tpLNiZWWZXwFzLOsfdsXxm7MjKiKW/dm8hb2nGHYwzBHDgCHHFgYNt8Xd13eu1bkXw1RLher
LdcfJYKVcK8bqOg76lf8bG7DIgGeu82ECcdZ8bpAQ3Y2YIvV3mtSMpMQt7jF7obX/q0ZfMWVcHT0
NFEL+3szErV3Nsd2tu9ztuXWDmlEscSkgQ/rxXMLeCnSYAC3ZbARyYPBppWdBizrR5aCWl4Zx9bj
WzN6OgWzYdauRMxdCDc224LF9cgRzboNq8e2wPn7wu/dxsQe6C+znCfxOQRNtEV+ytHR+jrHhToR
d3N2yD13DznJZ+ZGNSTLM9jSe5bzltwHQdn9RK9fowC7LYZIDmAaOy7GusNSVQAYMHvjKccokiVm
1BavKzaj13akWV7IIz1FwsqzGAH9jWw/LG+hIDHiYvWFecXqO48vxIpU9rYo2vZhYG63Hx0n+K5H
C4fYGDHwS3woBc6O8M3Qea1ZvGzbORPnWmUKw/zghtZRppZWu6pb1oh1wroI/dyqslxP7JkL8A3D
arsPweD2zceQMn9NQESPxaNv+s3ObEZSf8qms77VI6TIOMRf6D5o6scLFJHpMSv16h4sqe30YGus
AdlkZ3cWc+ynVow2phhfLPY2tNKJzUIxGLzsSPzysy9fcV3vAhfu4GasF2KEynG1sgNe9gV/XcWC
Z698PZ8DNbHp7UnEuS7oi7LtnE7quNhG99wIloM8OUNRnzNv9KY4NLvooc4Qt+xme0FstqCtxrUb
RIw0LGYOSJRT1eOrSlnlFduM/CfUPbVJFBkIjuqMlxJXIIun9AkshJKHCWiZz4h5UgcPmQ0y4AgN
ZGFm3nuT2djVsVvMOoEePRxWbTXvbJ/Xj5UDIEgyt2iT3gixG3PaTsx7fYunxPd6ombs3Npnphof
SCGagksj8plUEAxQGJ76WclNt0TOkzusLd/srPei5+nLhkKZm3RJi2emiybdQOrs/JKBMVIsdtkL
VcU+aMhA2VjlTDnCIOEGjck9TjBwWt0+X9dixu0aOEdlTpaFA9/XCHAt3FBPLlJPIsTHyXxucg/p
WR9x3VkLqSi48+D8keMrOHvABLiva54/cUxbJbFc0ygPMp3H8gODSKTRddflNmATfSeF4YaXIuvN
loiBWo3nzqaBIjyjbFiUtgzeNiv6A16mJs7FBtAQfrVyPk2YUllaUVrNhJw03wwWHDx3U6iZsfS6
AlCF9KTeWIRq7xyJrf+7YZDEQGCD6ceZI8yDi0+supAXVXqHInTgz1iqJClvI7MIWo4RyUU9kBbC
njBNv1r7FpJkubp808T28hpTdRTe+dZaNmc1hxGiN5hnOHzTNjuWqcmPUNPqfayRqQlxyYZuP2Es
qThrVWUdGPwV3pFJd9WeMM6UcSj1kO8c4uoz9iTrOMV921VyG64NBBujzZLI81cqKLG8kEzST88m
QSYWCWmnMJNsV3u2EDpzDtL08rvcXSvwHlGeZEPNatPyswTlY9YwVyd/ombdd5hNl0lV6Kk17jIf
2oJVmz1BKFOwsRFGxFoW3r6vDVZPC+APFCiEY02PYLJktUsnu4oOo4eXOI9a8xNqi6g4SEaxI7Fj
OTe9mF3sqhGyAaYU85Jov3frDw04Ot8gqYff0XeLdbGHXlH1Fu50MZehs68R9AFQOGhAvpe8XCkM
jCg7tpVfAQ+pNKvzSfsPJa7nBwQVXfilqynL3iLcB7Hdr1HJK80PPtMM8GruiHVXd1pTTBjmJ2Sb
MNwyYekfESIjYmua3j/bjRUybwjLDqOpboytLPPQTsLUcLb5kq/zEY1BMyZdJ+b2hLg3/c7yjGIQ
bajxSRuFkd4txGI8kxQRsnZa0cXh882Xr6FMqwUlapvK75bqrCJBpUuYPM501Tx7FSlD0yCxUo4q
yqm15iaIu4plcewVItrZToeioZ/mfDsjPXwZl4Y+gYHgciIGKT0Svdo1G0Z1RnjhjTFt6zzK2L66
Uv5uCbRiz4TQdy6r41JV5xEqd7u0yCZbeGY9WcPKOFaLRFrd5dkBBUN6Pxdm/SL6ZKCU7xkKkQg2
8QCgARmae5xNODMsNihoIjmQsfWuWUq7Ua3Bo7ZL6Wz02od3oSzbHV2GdzeauIg7txl/14VXv/LI
ISsGwnzumbwmRtgbv62MJ4vQkm45ajNK9ckjg8fEnSIcqsalzUA0iXEv11UYryOiVLSpXZjajG2t
FoiAA5YC5+Uyx4tVetObiFyLLiwqw001D/BePAPqDG2WitVQoapiDhrugiBsrS0BXPY+VXO6Hgvk
8xlBJbmL37pvzD2GaDltUeno8mj4OrCPCq1aewlJPXU2HjftBysxQJwjyUZ6N6xj116qcdXnLred
5cixmB9pqnA1171jFqTE6OUHb4OSbcraEH0+oww9ZfLWdxWI49GpDHni1xOrIPTi284Ufn8Q5N7q
p3B2oe4qLK0PC/lu32XQT9dbVPA+hbmEFgcnPQyMKu0u+NH1h0lurILXM+vRjtvRHzg2s2EOdnqt
S4nCOMqD05CKsnmBI3YTLHM9g510RPXh0BTj9E+b6WmeaufRmNP+G1Gp5rzLZ389Y+8YzgQ8k3DR
2BkrTBd55XUl5RXzfEGm6BN53zbCSeGiX3NwyZxBgSx6J11zvquCoT0gjlKsKEO/mmHWEGtTiEn9
EG0x3kNVb/sjA8fqOwJ/8IJTGg9eG4lkXbC/Xj1iXj89i/o8tgfllDSq0F5WyELv5WDZE87inCiS
6ebH3MiJNehm4P2D36K3o9jwceP7nS95BfSBuDil1tCNIur4AcXqM6E4dYyAiP8ZQbcpqmlIlpkc
dmGRQ2eaMtiNTuggvG9NcDBTnn0rvcx7AZJEEjNW7pmQqLp4JC7HfFMWLStxttW9xyxqhzCRPS9D
g/QTO3PAbM6S59Au1F2OorGOZ5FJgZ1QT++RL4rfNbIKavI5mvcRYqU7f1roywdfzXtodWqJAb4N
90vHVrQCati/di6Bh3mfF/FK6Pia8Mh52bZ2XZ/0Ev+H39vGtZrkWG4asCyPlKTd5zjd1u5kgNLJ
rmAytq4DKopjIhPLZho8Ok1M+/YR9KW396e5v1RAdC7c0VaM9aPE9DFK9oSd9YJA7BlHzJPrMd3Y
lE5hRtwbNbSF2ZTrbw4aC7qrjtwk9XN9XKjfW5Qbbfveq1Hke36ae1ehJUVqoG7RTFPn/GAfWO0I
seuOeg0svW0F3oZNqehF0sCNPkPZGIduFsyojBl7A7aJW6oQYidWmIGbIwSyhq6PJefBm2FUUQJr
hhS5fHC7o92TuAeVwm9PhS1CtqGYcjaIPapHowjnT0NlzZMvrQy+TjafSVmrL1qlGPEdC/JMF97C
YBaneoKNEOxMGXpbwn66+6GHQuODXkMbQ/OO+oAFV+wPvv6GZaqJh8AmoYZQVo+xjiXJu89zEwyZ
MI1o7/BCMTZ65hdgwdimr9LHi0FiEy5zlVq/eaFQf0u7PBN5sx4ypNVHNUdE13TYv+JWT/2pWdz5
JfIWVniWFTYbaGCpvyOwT6hNAysonhjBPxMq7u8hos3tdvYnlryS7O5DZ6dMLGBAgAQZyXAkI1Yn
ljZ48QRLl7KYT8epihssYaRHmQvInAXd24b0Ev7etrbmR8MOc9pkqS7uOA1xKBShQvlS7D3NucYi
WDgbxrf8Rz3Ki7d6Ke1qX3F+kNfr1VniiCWKNV8EQAzfni6tFal+Ow3K+5X1VbfjTd9+G1FX43Ao
n9Ie/MYVabAX34rn13Cpgudm/COupwvG6scaRuJ9UYaLOHwlCvWBr4PHZxboGvASdqh4R3LSoDI0
xr21+n6JAZ/ZIHXAHJp71+6C5VCUCJwvLQrIL4KukJQo5qKxcmgskqIwFFFCqrZ35gLSOI4sSWRQ
rlJ2wPnE6whk0Y8phTCD2eXBtcpMbntBJ4UYVE+XEa3sM0YVezvxTD3AIAt/+QuTqaWxtbMd7Hz9
iNrU/UgRZjwxBKOXjPBGnEOeLotxZY8bppUVLXQ+2o6KV3Y1sBzW4hlUW5kopwh2kdWmxU1wH0Ch
qLkJdsh6wfGxQSUHDNdIcPGmAIRl6Kjs0Vdwi9g6+w7VL3fehkZsnp7TFVXSm3HxsqAEb4C5EGkS
y6ukqmjU+otZI/eOGuPnQJYSQQj047+QeRrWzkiJNWwRLyRwIdazVgGRJANQ1PygW9V/BW7j7s2g
Ixd07ArYfYPFR+ueIPGNYU7q0TaEdT/XXLioMsddFSG5MJtCUw8RKHDndkVE5qeEB7A1W8B/V1H0
Lx2S6iBU03UN7eXJnaLiskI64JRFnKVO3j5/rLj9Dks61MMWzdoKf1V548datEGA/AYvBkkBsrsy
k18oDzuaptnO8uPNmw8L0JP+G72hPukQCZld6XlCElIPPwVFJRHgUfjvpJ3XjtvKFqZfaAgUM3kr
Krc6J9s3RNttM+fMp5+PPsCcFiVI8JmrvYG90UvFSqvW+kMCqISlsZA70SwtqlPotsgwOXwjat8A
jig/gUIyD6XB03FF59qPl76V0Vo2J4nj29TKUntblhNFw8/7pl2Qdha3fmdx+pKyaSpyoUP6aiey
Ly8DSuD3PZaWwAgblYOj0Gr8lUO7aM07VY0z6MWIiDgoYQMhpavf/VQarDw3cWU2OwUQqr0BV1d/
RA2MAj9vow9J1ax8aXaKvHfHsBdrHg9DtwkK+55t+Rj5VA58+H24p/e6u0OCRdPXdhXAG4Y9xYkL
WF29xSNRgTPg5vYyzL3yG/AUzcGUwy4XsZ247yVPHttRGqvDz5Upe4OHVmDuBTtRfVIB1C3dNsTm
AJfpei06KXGB6lukTeDWqmEZ+G6H8EisURhUO6O8db3B+qSg+TtTkkdoPoEON8hS7gc9yOT16Hdu
vPJMN35Wa63ZBKUS/FHjCN6vW7kknpaECEtqQlhGVGqwk8MQwqpmK/hAhQp4x/QpjGz48HIrEQ7P
nv5Nc020WGD4hjcyHpiUlJpYVnfKmAssMkepaR2gzWWy0hKjQUpIa+poFXtJGQJ3BuO1KuWE1mQt
UGh96WP8EBFv9UY4GzryBgt6ge6t5dn09asgjyD3pbF6kOB3qQs78QbwlAn1/TsfuyWYBqUOExWH
3uCXTHG8dSDXBYcQaTUdRLE3mFt1GEJpQyvawBNs0lTJyZyMJRJ3WOhksE8ePbmwXnIDnUSnYWUf
GrPhd0ApEtHO7iJJckqdIstfiXYjfFBsUzKxVcwaSv98MnSdqqL7SPyqU5xCLYqPljLd+Fnz0Iof
WvLeXcoZiLOsqUBvqHJFeZS9zIgAdqbyizRlu1tPU+VqC8vEdWqMHFeaJCX3pWsA/5Mjnbp5IeTf
I3KT6z6VewljCgxaHWimeeMIww8PMd993aslqAZFFmtyk+BWa2t33MSSVz5WnoJvdoab5wIu/Xhf
uyJ4IK3r7lIVX1rHlPucgoIw+b+M3v1MhwbClBTqkONo03rYfqchquICBJh2o8JXw0O4ct+AsWPC
6qLpdLAwygY5UlOFf8LR1obuxSJ+S8aUlBFCt0RqIHvJGwzyyQi6aLCsG9HbYQF51E8XjeSFb6jY
Vrw1qOajFRu7y9HQwAvWLgczPuZISMYWHaCs/yBY5K6EZBXP0iiVr3GSA6mMubF+40kbPsRJaIH/
QYR40xqWtQISV/MOtio/uckoFz7X6B13wLOhPR0CvbH/xDUv18ngTR6XaF9U3UYVUI3XSNDiSOuP
QJMWXg0HrId7FjkZQmG7NIk0iU/TZhuMKYvvSPWAtG4wGhV23T0LVYTcrnEbL9zfdp5Lj4lUlevQ
/gzMBYwcTPFodFI56ElAY8dIRQYPMJLFbxzPbUwvQc8jM5i6E+TcT/z30PXzchU0MU8zUbKe6Snb
r1QF71s/fnFlPcqWquG7xaLzqpxZROWoxnSZh0Ye3iT+UG+rzDBvNbMamhvUugR3mavZ3loDLlju
87qrIc7jwEzLgKm+0+oiRam1aUMs9lx0hxalMkrejTA1OoQJiulI8IJdAzKZYbdNNz2K70WK6mUO
GwohAw9OKj/S9yjQD3StFn5W5ltBz/CpmC5dDx+efGHYmIg7Frv7B40+GTknJA6QZbPhiwYlhH5e
+KPyUiVhet+aKZlgRN2RT8XrDcoe7PVNiGyRvEwLi+dZF5RDuJfl1vwmIz9wI0EmGO7LrG7khd6r
heKkvrz37LALlgnCdsoioh/xM5KLNFiDb4u79zynZ7Eo7M4PNpBGuGxLPLhXLewnWnVUbR7zrh1v
fGQlo8cJEs7IrNqLH+Ratx6DQKnTfRwOYE1RJJRexyoX95OherFA722AJlckYpWKUfCoUwyFRMc2
+tsE0bp3gHqUwj2pNpSVij/1gbXkrsmjxBo50ybd97WMNDV5IjVNXc7LLb2u16xqRvo5SK2ZC3Q+
zXGjJJZVL0MAmcpLQSomQ6CUEX9wUb0iXiPh5cjWRstXGBDmcXXmuI7Bmb8h4Fps4VgjHJwE8fCT
iZNvg0mf8wfaDZg9JoEiPdMUjWmutJE/Urgz1eeuhtbBi9OtlpFcURDQwxKuGL2ndlcnNhyh0YMS
s/EqfXwJ9QBtt7jrsZ0Z1GAJg1w9DJSrH+mihz/SGnNNTCCScmcCCYu2fpmqP+VeV+AxTdDWxMWg
Z4VfYIga7wB8GCmIbFxSmLCfE0E6cBujghQ/1ZkLCyux4pG3cWvJwxoIA4LfSCjYFBJTLxZkI6bx
RwLvEu9q+Cs0axLOR3yD4woBTnKInzlNnOEVEorsAwxOoo4li+iVMwwaJX0U5LvXtg0TaCx9kL5W
XW+TI1cWVXS66xI24wFl8zVUPsl/rN0aejck5uo7bvXJLhejv9X8TM0mTYfxLQDH+aev+ujZ1yd1
Os0FyMrcGagFUOeAjo5xM9BgyjG5ONSdJwd3EUg58eT7Ays8ZG2ZNzpX9i5JBhkKG11m3qQ+Xx91
baX5gHBe38lRV4y8I23jMVA4hyGI18kDWL7qWeXZD3JQavNg79ZG/uh5+GMfOtyl13GUed8NEqEK
0LNLrTEUyAFXdjV8IICLBn7joYvreCWXi6Nwb0NkGD3gkzKSgtUy65vgQfViddzFk9ct8rQh3tSB
IXiNe1H8ngoQCAshV/VLrRvly2CYUN/hIEoU+4Nsb41F6S9HWwLCb+MuDQ4Z4e8MZGykUEzKG+RS
ePygrhtIE3lWrrVf0dCUN22qlw+yQWKiaMX4lhcDlAysN5YYIORLeYzbvUHZBNN2nc6BsdBLtBU2
g6Ej6Twg5Auto4hDs38Kw5rOpylK5TFMG+VTE7mNPU8Ajy2KK0v5HpADUvscwEUsaD2aW3zDKavp
Iay6XjF/yHlj3WD2qVNWL0WxRFvWjTZdKYDymhiarxX0cVBfV9oNnKoiZhMO2quLGDHfvOFAMuui
8bcNb2K6lkklb5VG45EVpHZdrEY4nCud5sQfriwZIaccHxBXR+O4wqwD/2Za4lkfQWFjWUGtMqj/
ZctUCqETpHqdN0+FUigPVYBgcZC0/Z2whfJNLmv5YPSyvipy/lRB9x5llqDSE1D6tBBjpcuRccgG
Vgk63Sh5CryK0dMLrT2tn/6dSlG6JnMW4yIZcvRbVB+bHz0330RjhLQZlOYu7xp7i7gc/c6YHjTv
FdmjgE9jDEUbl8b/J3vJXbV5ZT+EJZxXEbv8IM9Q114ii3s1aLDZgeCNPAPHyXsDen4jWJoreItw
SGvXV5I/rkfudwg6tOn3ngXYeOnGnMdbknSINH4Xil3cuclzKFfdDzUNPFQ0jA44qufZpfrgY1Fc
bYHwpfuwRtOht8lz0aboM1a0kJKnAXwD7Uy8tn8LxR2/K5VOZwQHIPQpKFcOr8UoasS96QDyLbQk
d3ed2qCe29mY2atsww2qRwgZqyiW17A7ovjJ8yyqDgBZ5KeOGiaZFFW3RQVcHVkU3LR5FtWxAs1C
tV6xAcjwamwbs1hVISoKS5QnG3gt6pjuXNuDNg4KO5fWZBR56cT0CLfI0o3xyxDAhGmlpDso5HXQ
jiNOuXXGlXYD5K+REWFI0gfdIskZXCxzqLyiaM/zRrjkLdPErd2KpPqeOqfl/QAQrbBRSn1qbtFF
WHpInd42AW4rCGWmdftmZKRZtjdUMCkLCdoOMhMaVWeLQhpbvOARKY3yEgkd2hVVZShwUc3tGNft
CuPdDedF9OD2ZoQvJ9bzT36T0pZnKm50HQw33XavgtMuuyH1Q9Xb0v/0XnIpYF91TXgHNZYiNUA9
D0QJeTq0q3SS3+BRz74Y+WCNg4sBuqajVEAR6v3yV9lGk0QUxMIfeqhzaLmFnzxUGZoCS3ThQqwx
QtTSLLoS6RMS5DQvhxTxdo6xO54wxn1T9+WjHMA3Qn4+pWPRJtXadiXeK4iets7Y5PaU08faOswq
zVz5CuTAxuIcdlBbFE80zij8FvwthNB1zd0NXDbtvjaM5r4rWvCNcVECji51K4kWPZUF1CtcuHQg
L5rsAUKjctunkq/egK3L+p1qBJS4rFJkD0gaRDR3ULpc0OkPeGsU5b1Xajp7o0s3IfnNjQwt5sMt
o+65rAFS4jetd4fSbsZqlSeei9KLSYK1RhQf+Sg5j9sdlWvlzSDzfpeUYKBCr6u0HbDM+GgyF244
287NHvq8hw+k49BMijZo+w4Ouf0e96I8pPrY4/rOtKjwa5IiccpayouF2YR0vUQc3YctH2hNmiBb
1JZSFKszqu7pI10If3gGSRCX30h7wOFLSeFv9dKP/lRCWNImsdXWf+Apb7Ub8ODqEjKMkaB1rdnm
otQyFFGmNu6ktGT1VOmB4TxxDEQglwSqZfqQJxsU+5VXU26gllPYWvHFxXegfTmnoM79N7mMuiT8
3Nwdj9hRn0gGZRtzLCdt6NIfqujp2hntGhXCg0FpnQQAEUn9EAaKdogER4mTAIx7VfFnfdNUYS4j
U/E/LYWfsoVylKOF3mRWyGtRpjLFL+79G4w0+nd7jAJjHdhGKVacuEjPt1yG3rttldanN4xKtEu7
jDIS6MQyXZHAY3Om55l8O9glqQ3qP8O3OtXCn+g2qx+F1VYSYLDU+gH/Oawdtcihd2mGZ33CLrRt
jnj6L5RQOxPpF+DUHF1SSZvID5P7EFXobCWDy+gWtolz9jYKLfuREiYwEDQlg+cW+ff8LnKhurMN
Q52ERevy9j7RIGP5ctv/Etyrv9Ws8KGqRArnTmYr0zoPrf6bksva81BIckyXHSv57ZSemXQLKS2t
qWcbA4ofaDYcwKJhyOnClUUhRbHrbyWvyZuw96Nyl1Wti4Y4B/WwCGGE9MsuUaaT2mupHsChsgW8
3AJ2PKI8erQaR5fad+RJ1RuKKdpPPyXBd9TYx3rF52qt94FbZ/B4LLvHNkVqss3/qfsxbdISynAV
RGq2lFBg/mM1lQrzlQr0U9Sgi469QXgYeq/7UMIa41BViP/oLf4Dqte08AEybRndUDDEM2hohj9M
hU+CCuPmCU+m24SNa5vj7jIG9QzQll6ksGiEworRtMng7Av2VeQh5gs1pJBYwX5DesLfYGFnsE4O
uXZFLfMM1tXWFNMGXq8jwmrNBgQ+Cy+vhIru6PNiQ107ytzHy6M5RUKbGLEYVHlUxoN4yPFodDWX
+iYihJo/5pgVjyuK+JdDHGt+TmBhS2hCqODLdHgNygyZHPkZWBjYPjSlJxlXdRFEGwFMdkTp63Ik
ix97jIG2hK7J3OY2znL6RMb4OjVpYaq2G2RgSZCVDinrwQriibA1+l8JlGgknS7Hm3mt/WdoiKfa
YERAkRsTxeNrwAwiTgnOFvMfZJlaiodC3qflJrBvw+AWv6CWdq9xBXx9OmMA400wbApSsgaU9OOY
ikdT0wYbt8jaJyVrti0aHeo1U/vTlWcLQ+a5DcraxJ98FiS34iYoJ0aubN/3zVttHa58uWnSj6aK
CWLFwSwAiWywZY9HUVE/NfsSYqdWNU4BORhbs1A3nBLTTCjMkw+NtFDbD6V6wwdhRW1xF4Tm7eVf
cbJeYBnAxuCwUAxLVpRpq3/ZynKWAOu2UVBG1+c+g1HciPppCA00GyX5QSnCJa2Eu8sx/2LjZyNn
8oRsYMiJaOlccdeIbbCXvkyRPLTvyuI978gGKq17rKTsMKTKqumMOxpy1CiRHlhC4HnoLdWBDXZA
xn1bed4t9llPV37VmfngVyGgCoNgYirMNmlZDXStYPAs3Ppnlms3ghxMD7UCjvCthX2R1yP5nTav
thLfS2jvpIn6U9HkKySGsxNiCx7sNuerYs0mxFTo1nk9mNkiAXKpS0sUUxZdgdKSJW+xbEHzK/p1
eeQnx/m0Br6EnH7SlzWApDcN/JSQpbvOUQp28WvpaLY1ZbfN/Ct792RbzYJN2rNfgiFgBcK5I1gL
OoYLm0amyXPi8ohODgiCsLNMXdE4lZjM4yAAIgc00xD0EYO+ommwwbiIt776r8c6QoKmiRQvB4Rt
YYB7HMYzpbqWatUla7cehlT8MSyd2khSvY6jmb3965hsTXDpcrIbGvLgszHhAFJItW66C1R4NjLJ
kqe2b6ziKxfu6fojjK2iq4FDNayd6Sr7Mj9Z7SltPdp4echvNbRXeuUpCAHQyc03fPicy4M6XXok
EoiP03TkElbnhyzqGH5tFyjX4ppTL7Sg2bVuu4r65DGyx1WbjlfiTb/++OQhHuRFhaOHf853VxBY
lPpknEq07GdryHeIQjylA2pWqXdF7vwkElcja4JBIaNsYLZz/B2lqUuVhoa58Cf3YNvKtl6L4mWB
5CsmI+LKSjxWbCYUVzBU+ynBgE8JRe04mij7sgGJxxZuEHB6RsCsgweSCrp/5ippv6UoOVyeuZMt
NkXUzMknF/amPt9iTZEkkSeImIUaRoblqtF/u8M1Q+4zUUgvddY7Wxmu2mxclJkGxU4Nmsz9XZ8j
ROPyJr9yBZ6ZKWJYzJVGFiO02blPIyu3NA8TwEA6WDzitXJvxu9D83b5g8nKfO2RrmgGHSLgPRim
6rOsua1VHGVihTyzkuSDKsC8FGbR7xB5CW+GRv/jqvgvFR61JhycttEA3aqke7NSQre/sjpP9t1k
YmxQK7Uo9ZHgTKf0l13eVUWMXTX6F6GidQAH6Ldbiaa+qFob73j8UojQmvRKxnP6oVVNwOvV0aLn
mTLnAmro16Z0Omi61/YiKn8pYly70cE1Xi5/6dPBqZpqsGTg6IEknJsaeINejGUNkA+LFUReMDQN
9JsEvEUeOLn953Kwc4NibeIpjQsFcWerJ1HbLpCRMMCALH+Au7mD8gjurzvgWbC9HOrkaOYRxEmi
CAZmwKOdxv1l0iJPDdvRSycL0WiZuW9VUSx5s6NEW63S+hdNwcvxTjcfhtDMlqEbtJFYL8fxfDlS
czX0kQJotfIGdxe07cIx26Pp3F45TU7PL0LZti7siSRKMnIcKqgMvHkrvJlQeo52MvU/jGSGZNkP
RoZWrQiMvWcO7Q2d8TeTxviVfGFa7kfXAmkfK2U6BUxFO1kxfYv7G31iHHGRZkSKaSGK/eVvefpO
moWYfcxcthr0NkGoJ4GcbrNWGpYIRTW7EtCXUwz0XlU5/YzwlHG6NL5XG1H86903/QIbgrewFC4/
ZfYLEjxvfA3pYXx8QRokrXzIsIHR0uFbbBZX7qMzuwKCnK7iVsDJrcwpqqCE0QUfyfLi2l/KEsJs
twnSrWn1/xlnOnO/bIkSXcWsl4lD12vZybcuXe2gspwivnJJnFshODfrqk2iPNU+jgNh8RR5jUwn
tsjkxyL3foWmdGUsZ7YbZDuuOZnXIM7003//MpYOMXQEs3kVIfyWLyq1dXQFCUlfL66s9lPuMmof
XyPNVkIPrdXyM75ao8G6CR5GFp7/u5Y0UIyJI6H/HzQf+DUVhnQt9JkzjNA6FwDFKf5lNkjc/rAP
7RTem/JL4N3T/tMQEqoeOmUjaK5piHq1e9Fvcnhq5ZOPAltw09hrPUI89ePKljz/wf/7W2afQQvR
gAymxcNvGbKNV99luHMiUaDqB0iIhr4J+ucYdd6wpUm6MqI1jlKXf8OZZUVGYOAAwrmuq/MrUW4N
NTNKPkde4rqrNjkXFhiKy0HObEZD1rgxENyg2jB/4zeAROFDU8OF//JHyfQ1+N3fEOdWBQ7H/xxq
ku1AKo6SkMGz8ngNF15XaHmkGggUlu9tMDzmlX4D3uuXG6HDdznW6fSRGeJbQAFSp/Q0r3VKnVIU
SHqwilVpgyXWLzVSYBrb3y+HOf16hOEhpKDRbcrAyo6HNLQAhbDFpQJetwfEa+hAg0jOhhWvzyuF
kb83+PE9NB0tiIkI2tTmf5j/X44AW5OqIm996gxo/FuPOVX/naeoUvce13kRrtWQHsqK6rj1rql1
H9LwG7mtpCDqcPP0hmAHUdN4Q+bPRPW5zLvfsQBIi7z3CB7epDmH1nuik+TWyOf6a7pp8Z/BhdqE
32agvykQJR9EGdt7lgwqW3nbtS+5X0Jj6VUjpVSVp/FGU0P8DGQ/KF/x+vVwza3D7zQz6l2Y9s1v
1wzrHZyFPrxyQJ6eHX8Lm6i5kNpxS8/2q57HWNUGAEOS4mdgh05ofRZB5YwFfr87U7ly4p9mkdNL
0aK8qJis5b8X+pe5IIFVwUxgXC5hAqOq7iO9u4XctLcaN5mKpeo/LzOkKxQKjhaSD8iMHC8zYUAH
lisb0bwKMaNmpeOzgN2i7KZXAp0eOfx11aa3PnkGkf4fB1L0sq30MLKxM/+OvHdoXJmlc3+fVy9l
NDYA2dwsIc5tuIb49FqgOLKfqLXiamG+/fu3+hpi9q2kUGohOBBCwLGhN7lgtzgmTibIRV+OdGYw
QKiow6nThawqs+tqBLEeYkNmccZU9G1RSVGvhThzvhyFmK3qemy7DsqWBdNSirFaQW0wzES3HSHq
r6pM9C+Xh/S3BTA7ZKjuyOTbLACTfsTxAshSILKIHNsLAGoLQ833eYSZYIxBLgoMIN5vQLC8IGfw
pIW9Y/mwQLL0JoMEbcIvkJXw8fLvOd1nBq0dKNsmlBgbV5Tjn2OXYxgHpoTreKo9aZoHH7SE+V1t
w9HHLFK+8qg5nVHGDZ2C9oGpg3mYzagX5YaEGK5E+zdwD9g//+nGerxykJ9eTZM0DE9PqglTnXv2
UqMf4WYe0DBsGD+CTAA1N9eSml2ZydMvRxQDJD6lGIurabbTohymcI+qt5NX8q86TzcuDNteMmEC
lR0GP5W1uTxV54alchVSKhFiSieOp2ps0qGVZAikZvaS5vBnA9ORjWsH1OmGsOlHaOhQAeNVtZPu
juVHXunZ9D/MNkSnNA02+L4ixuBFT6beyVdSsNOn5xTO4qAyEH45eVXHrmTWVoG8CmrfC9X9Buhy
FVXsv6bfqhyTBiY1C8PXl5e/5enkHYed7UJwV2hrAL1wwqbfA0VbQ9HbW8g99D3WKUl3peBzOnWc
+KoiY8Fo8ZyfbOW+Pi4QLUghKfpYePbNviqwlYiG7iZXpCvl4zNxuCrJ/9Anog+tzpYITupVIZc0
r0LMn3UYPY04RPG3y99u+rHHJ9h0H/83yOwKgwyGVjrJq9MHXeTIHgBnBE9R4XFGUsHY/eP35fPl
kGfeTDaNdc4MVqYmn2TqbZB3gA77gEdZ8Ig/+1qDKNWX4pcse499hJF2Kt4B41LAK5aBFl25tU+W
i82TXaCux36Q6VJNq/hLNtJAKo/bieLbiRaT3s78Zaem/lGojewgmwlcr0iH18tjPpnLKSYgAp5p
Gupn1ux86TuIHmjEB04ZKsXK0FEF4lwOVl7HtrgcSpkKPEdTSixSOqJZBueyOv2WL+PzQ4zZ2koO
HJxy0ctAzhEw9fjmxqjJRG9N3AN7PsDyuvHj6VM7Cdi2foO/zTqPxE5q7kr3t2nu9O7KdaGc3BfT
D7M0ZNIQ5OHfZx9hLIcuKjS8rMeUIjwFMIwOHDutwPaCNkOWc3Jud8CZAncPJKOpt1mm6A9+rEgr
EZSNu00CjOX2JYcQHmZo8CyBJiqPHTjIdlm2Qw4LXOqlGyTzU82RI0DODrx/8vUiKdRvjRmA2KMN
GTZXTqCTc9YWKucBzzVBD+uk04gxL+5sogyxV0jUAw+ocZl3iMOKEcVceTJnuDzHZ+NRYmPjUuWj
LXI8xeiftnJlAHyy/Xiv1N+9QEHZYS20K4n7mWVLS53OBCkuG2b+3A1iSA2oEzGuobhjZ/5C/2Xj
SdaV2/fccKYiOrch3rFAbo6Hw3xj1NfBbIjDH7L+2bZrQ/3M/StH3fkoOjK7tP0mBPFxlCAQGEEG
Suh4YlePn/gQo2X2ELSfl+fm3DfDTtmk80fOwuF9HCaMa65B1w6ckFtiIwV6guiPFgQIT4XZleRI
mSZ6ttf/Pg+4iXjunOz1kPp8ZgZR6Ch+J95QjkDrGO96+bEfBDDNAZQoeoE4+/2s0s5cp8AEXzEL
GQ8JSF4U7pHtTZx2JPPZ0OEDPW+Kyv2skEN4GX0v/mWalb5FJgEg69Ba5nctzOSPf/9eVDkER7KQ
qZDP6tVFw37shBs4jTYsXR84u51tbfefcUNs0a9hZlsmVdyImi5hALxB5996qPLrUQQR8+3yeM4t
M0Oj9G3QbacjO10/X45fWytQ3NIkxpOgN75Ie017l62oeOKhq/4aDZ8D8HLEMxcacUi5qOGwtsXs
XK3sUGUi+3Cyi4KPJFrplsn72acV9mlAbVcdtaQrqd6ZUf7n0cvjh7fP3zv+yygng62CJz/Qyw4t
wqJzEt4Bg5Vs3S65kgddCzVLUayRGkkRUaSIsrccyhdoWzDG33ztyiF+ZuMeDWn2GZGDrXU1JQ7A
1aVXVSuzDrbN+M+ypFS9UT4lKbdthfxjtj5EIEqtBHXNl7OWjVzeuZDPkR9bX14U2unJoNk8Ow1Q
hWimmbMwaltmYdhMXLzwvTNKEsjnywHOfK6px2SRmFJno+VzvM5zN4+wzGrwQfK7P0GdrDOEOEDs
XrmCzizuqdWLshOnG6/a2b4VCFj6kgGgFFGFA4U1ehIIjqWftLigCQ1XttJpbgocbmobyAKt5Skz
Ph5ViXBeNKRYmSHbG6JvIfsIlO1EyiG5NhVE4xpEFMuVn/774iOuRsGTDEJDDvU47lj4qSvlUCwg
1TtqpOMjiWa7Ka8uT9q5CwPwp0wNhrqFTOniOI6BMxwWt2nktHi4etg7ScGjbb1q6L8hBkBvoA5W
hbtXvU2bvSEE0FvPJVKc7Uee32gTdH/VN/dUbi//rDOLlWKdAIlDdgxWZvbVYcEX+mRXzBbfwLiE
J19dmdhzy4hVxJRCGEQ0YnaI2MjPF3FGBItrf4CuVd3XtLRRBamugSDObQyLy1/mJJ6u5Vk245mG
4aFDgHyOl28hGS+9SN8hZXplROfDTAWf6Wmhz3Oz0dMqDIgJ42WYeNLH1SMDbfr7yzNzLgrnFJcL
yGHeLbPBKK5vA5wA9t5VB33S6Bqxw712gZ2Zfroq5M0yfSx0v2eLv4iKXKgp70+zabY6jEDm70rG
fGYcDMHgzU4lyeAwOV73DYYTalwyjtFt31BawcZZvhOx+a+1AYCuE1qC+af9bcwrcEVfp02omoDb
a3spN/sReysTK7HLk3LmRjyKMlvMA9LZYxsSpcUgaKoQNGiWDhLwP3HlMXnusxk81QyeNuBs5tOP
bLE8WHkQQ72LdhI0Hg0pEbcONpcHdFKFmD4bG58NSuZ0ksGopeJqde3jxaqV8CURgaATvh9s5IZ1
PmRe1Mum+fO/xASgCtCaKs78xK3d0h08k5gIwq6Clox4l8uPJdZAavKAbNrlaGfOH3Ttp0oLvfyp
QXm8/qh860amoleoWsaN4J2dtObSaLg4AcWa7ZXL/9y0Ue+jwGFRosVP4Dha4VrQMnSYUN5o7YVO
QdjSV0p15fVxbhlOBRzk1eWpQDUbU6Oj/2BLKBKIzMBYt9+HSb7o0HpAcPNKFnB2QF9CTT/lS7oZ
aDBpbYNQamm/TEaF8SLXx2FZGkP54/JMnTuM6INy1pFsMGOzUQVtFjBoQqEWuLMG8x6RqiuL4VqI
2WgG3W+93CVEmff20+iVISVEz3u6PJDz0/PfgUxL8ss38wdQ6qNNFDzKFyNvAo0u2JMq/Q9XK+3p
CaMJvInm+OyKQMVHjCncEpSqtOcJFNPa7nZUfGRco1tVsq7V784dFl/imbMH42ChjuO5GJHaOdTI
qvQzJ2txWfGU4rvroiQdeBs/i9aXv+bZqJP3BrVtCj3zFKWLPUxXsGJyxize01vM49+K3C9g6SSq
7DTWlXCnICeORNoC/y/etIa+zJ7SpSbKZMRDL9cZEM+SkGeTNYEg7XOn3ydU2HXEiMLV5WGeQitn
cWfLX5ORdsFfIqZdOm6QVNGKx0FF121TM1qgHVk1OAgjrZtqhwr35eBnD8kvY57tCwPnVSjbxKZr
wspBExBP+Ych9m5lvYMbmPx7cnP0jWc7ROtR+vSzaazKwcPHvKjQXoSOfHlUZ/fhl1FNK+vLTKJT
7zXltHIGG81hvf7RVQ10Gy8ERHnNiuIvkHBWEDIsKusweciowYgeB4vr2GsrjRJ+rSM+6zdIdRXm
r3Sq8QbuS7jFq09Dwgx1DFXsBNpX4YdrGE7rfWuzK+fPtFJOfoplaxPAAMzj/IHYKmC8mhwbqz6o
fieTW3ADTzy2vCt3w9nv+yXObNWoyOtR02fIkoIe4ag4Uo2GCfaD/1OeytKjGkqRF4zlLIn0Ckoe
qG+xPqUBW+IMsTEkwv89ryfjUsGCA1E9g2NSRZ8grY6mKFJGlpcf9Ng9NLX19u+rksTHpvUDiMGa
8+jMvJV8IBgxTqZG+mKIId6VqD4efMVW3/Qker8c7tzD2rB5eQH7IQPCx+R4YfpYseVlMCCEishy
W2PAyan9HZMpd9g3EjKd5m3cLbHQuhx3+rPzRchbbMq9mDOIicdhM0wx2sYTXE7YbKK/pG2iasDj
EftLXGj3fvyGKR4qqVcRcdMfPg4MOFSmiKBQ0yTvmwUu7HGoAxVzCA+ZWyTMavMg+f03qVIRaaGl
gdmb9Y7k9/hed/mwrMNBc6ooePJU9Ucne2+qVUZ3kjGMm6hFdsODIXPlrXKahfD7+DJQorlOxfwB
iTdfJU1cpkWhvtT5e5d+u/zpT2/M478/O/dSrL6R+5d5ZMubSHozFQTNHuNko1u4sTX/vGuOg82W
lxamGhprDMaNlwL77xiSv4Z00OUhnbkdWcCcZryE8OnS5mgEpapbOosUDoCxLzTzTY9+qOqrlPaL
Qj9EymvR3VTtGpE2JbrWy5fPzNfUZAKehzHY1I85Xsqp2WZxodb6QpG/y9EydidtW/RN/5i6A8qp
rJDV1LuV3b26UbV27durxQDtdDdN+wjcwsTxoNE/W9QSqrlW37Ko4aevEIaJENMqgn2Nv7cCIUC6
b5DabUO2seFgMOWk2bpXVmODHPiy0x6U3Kn8bUHKO7jI23cYbWxaaML9c4egh5gI0JFT6P66szRn
cFEzDZ+1cjuk6CRbJR52H5CLlpF0W+c/Eu13VT7b1r1mb8JBbDygFHQ44uS5Mfdpeq3aeSYfOx76
bDUHgemOaczQIbcj74aiNrVITHF8DUrrErjpcgifdHRfLq+4M5vo6IvPJj3se0mKO8K2w7rp6JLz
HfGbnBabd+AhfiVXuTLB6iy3RsA5woaTcBlanzUkfxHvox5xmNZRZCyNhk+BDuTlIZ7mCUdfdo5z
CPK6RdGu1ZG2MBwvR+4YHGaAacnlMIpyeiJPlwAvFMo/E+njeP+4w4DQR0OcYexx4E3gaD6n8W9b
38vNo2niIG0vxwitrfeujBCRWSvqJ/X7RacbiHphFE5hMldvu35TIaMmSfmV7PfvlTu7Mo5+4Czl
dxOIG2iL8iFQ1amtfYjQaqolhGPPo+zS/I4HeTEpzJrewxj8yHLwwMmixjch7W1nCJCGsh+B18G5
uLfQZCzNO6UyPi5/x1PQGwoCPDR04MKqSflxdghQrRDDUPEdvVFZSqZjR6+Bvyt8RwFjFKIbpplP
FiVyWnl28U69vOk/0Qq58rXOrpovv2K2HxW8JMzI5VcImASa+1mA9UzRrr4y2LOL5kuY2f4TFlpF
sdvpi6601ad0lMWE9tFven0sYUCh0NpkI0mUq1C9RHZy1TRuswgnP51KDawrD5Yz6T3f3pAhOU4y
CBRdjtdwK+wxR+NS/7+kndeO5LjSrZ9IgLy5ldKUN13tqm6EtvLe6+nPpz74pzNZ2inM3gP0YGYK
UyGSQTIYsWItN62eURIK62tNT+ETz1zL2XXOV6t4lVl/Xsb8+WaM8CQ7r0MNbujj5Yn5c9S/c9aT
LxHmn34XTdMavqTpZzjXrjogvXmykJnfOBDzQ0OsQAEnqY9y80GWD8H8ME6fdMnfoenYkbWO48lV
u5uackdj7zOj9WKo0ka9pSXrK0RfvDXL4+VvXolBl9lbOn5NA85QEX8OV9RgOcNkAAz+6qto87xK
WujWjX4cwYv4/ey14EhAwSvtxuGz6q0s2UKOAZeEeHFCUGUWfYSGM3zbhdu1TQErYP8Tptp0w2Pf
v4aWMf61JKxLYPuwAddYAgHBO4UelPDQLprvnbkxpi1LwtZQMxbNT7AUaPLO5+aec3Kn6ZPebcTw
fxB1733tnzGJtxKEtbY1hZyCUeXvbAhMVP4xvSk7uBWj506K9ypHZaB4s/SgoDit3QTRre4QFX1O
na9a+dmyZ/7lbZjuKYfT2PuYo6scV/sCHSFowZ3nDUdbXe4lg0gjHCXYP9v45MlvaqkPcoIPNiX/
YQwh8a0tqHQtnuWjdkhU/TDKM5kcawe15Vvi/6hrhOXQwzrOTr+DP2vjsFz3/JMPEs6NOdSrkW42
dIDNGTnn0lNk2HScuyZUPYRuyOjcNvLT0JquFf37650S1dJXwnxAiS+4SaZm0hBlHBQoW5Cvku79
Pt23abkBSFgbInYs6hRLGekdhFdqEpDKFhfCaEixJ6GY4aIuiI7ABLcttJvSgf/XP/r0XkLAyA2b
JRNgmd5ONwa8FqgvXCdL9oX8uy32saI7MKHjzjETw2k+BtqucJTPWmvu1LHwnMJ48YPhGirWOwdW
Zcibns1BeYx0/WD0yUaKfn1WTr5FiCm6xIF3z2D2uyUpYhwRxpLN+wJqDnhxtcGr5ewGncAu29gC
KzvgbA6Wn5/sAL+iizAHnoSsRHydWsMhmvN90f77wrFt0BrBADnyKB0Lfp0CQVCiZXhJfAOBsue0
G9WA9Qk8sSCcp0qPuKecM5DMeQisL6N23WRXyfBFG5+z4gbUoq7eDcWWCy1xtnDinY1L2DRglYIQ
TVRCQeuTMn/xJf+YyjdS/lSjCdKCKgPrt1WFXV0ybYFhmfSUUzc6XzKj5RFtToxUN9kXvn6Vwchd
5M7GG3qZsHdDOzEjTGiNJM5kLWYQovLK4RiiI5VD7vahoNcN4uWNo3iJ6i+ZE2aSoF+FD49bKime
lOwgxfcAxKPgFypJJD5gaeZm9Ir8p6IjCj1sRByXpxQCwvMpTeMsVdqUY1drQhgs5UeYue/71P5v
Nts/U2rJyrkZ9OhIuaWMsTQ+NO1jbH6d/Q+X53E5J/7zNNJddW6iiORQ7kZWLZklVx6g35Y2LGzN
lfA8S4pWhpMCC10YHrWRt+4Y3CxyCJcHsnixOBAwNuBAaAxcMOjnAwkqWu5tmSVpag12VlSh7Hul
asHB3ErmFkZjLUomBljKo+RsNFgrBGuoJhhNzMqge9NPv41Qvcrbq6oYPTOGN915lGcIq0ZiEiul
0fMoW83RHl+cDlW1n47+IGs/C+unpKFC+eS0+a4pip0+3ErWN9usvaRVN2K6tePu7IOXoO/k3F70
tFJkRLm7ErV5VOOJhEzR/tAcek75QQIoP4s+Q5ud34bTHCE/Kj/aYZdufMfKKp19hrBKJLp4ZcK8
6IYViQjVbGXeGF1/ncD0BRcLSrZBG291wC9HgeAaZ0aFkynIVBv9SYxm8z4nkTXkk1tH+R6YqNdB
0Sdrn2xrk/Vt2ZzvrBIi/smpqXD3nM+4Xoxabo44pDHUbnMTp7B0SgC7d/ZDaj3mU/1bN7MPtSld
X94Ia7lMjvl/DNvC4RT0Wpoyy8tb8mM3vCrq7z/sjfbHor5uY2A+Mxx+txWiYp2xcQf8gfq/HzRh
4ZKLkd/lEKyuUHz0Vwy3HctsH9pOtUOzRr5TfDgqeoit3DQfBk934pcwzeCUHebQQ79DJZIDwKVY
W+fbyunDZPz9IGHtQ7VrSGwyGSZt+1n/OoBz6vONI24FfWefWRHX2jSr3p+wEnPX9eh3RNNnuse5
9naa/a2GEzbMXXKnVgG1sezNCWTeOYqH00sZtzsYhIv2q+qQQU3def664Q/rjrhU1pe2aUfMwzV5
XmblxJoU3adxuk21ay099PQdjShMTYDCbzPdgznvstm1tBxz8teseu7/yUyjkYNytTs4JBkX+ciQ
x120b8GB1c3OhrW28L/1MURdNb2VVIksD1i7C/94Kn2AOFm1PLjcYtKTrX3bbH3fsvDvPJU+L2Ii
ebk3xJMINFcVSsyKqQ+7RTU1aXtktJ+QmW6S12necBFly57giFIRpIhFMB1xNF6RTFGiwQ2VQ1mi
S3gTlZ96+8Uw7iFZD8eOlOQ90h9oQv+Kx12kPJvlJsHFMv2Xxi+4rDmbmdLHy/IYX/Nuvq7T+YBG
qttFn1TJS7rPk66S1fhYTXzRxl29lnRf2I3+b/JFqAfkY8ao0EpMtrUluLlL/fJg+vc+BbGM51L5
0wlhD9lIN/wHq45Mkm3BTv25I0/uQInrubZazXDn9NVJZdfIv0Km7VrVJ9O+rsbGs6wXSZc2Bisu
PA2F0PXQN0CooBKcCPFPLw+0LEo2OBb5GpJ9bwCTYNxpyue6/1AUGwewmLvBwB/mEPDbqgzPmRCX
aDXS3j26g17fASHs4P5Vnc51EmOvpVs4JPEuXwazmKEMC8b3HVGcASd4Tl4ASuBc9muvmJICIn7k
kRoiH5iCjrM1R9dBnacbYfHKIE3aC2G1oNkHckFhkGi3VouOTeKNcAS4eFm3I1n7FRma+AZBeMW9
fJKtmoNUCg4NAGL6n8P/xG3qrkCIGjJuru83vQJZjXYr5H/KVub7T/bodEsyofSWULVdLk6HdOL5
iRnAQ7tIG9KuWQMJMhFmQiUwD92ZipAG4/3XwP/U5BCUf1GtIzWVSX1BetI2j5fH+y7PIX7HMiEn
A26T0ZE7n+8wY9+1Vf+QovOVPXFO6uU93BJ+fmdFXqbskclx7ejOkTayG++2jDARwtnczCDmJ5UP
0BFJ9wY7cMFKo9OA5GguJ3sY1/e1amzs0xV3Ppt94YD2UZUyYlhWSeWF+7i8qSHwSMOD1F9J4+vl
GV41xd1IMZnerncMP43vdGrlsHMgTCejdSzVfVpHO7Xf+f7GgbD4zDufogkLbBtQWFN0XjspLD2o
KWKMzuPcgk79Mm+lUtZNALeFWRHggfhKjWW9z6sFPx6i9ftHqvd3Gny9PGPvgto/PgmS+P+MCNFE
WIfIE5q8WuSGVjYKQ3Kzl7Sg+5r1Tro37Vi/CpJZfsnHND6kZTnctQCkeroapOg6QS11K/8gPpzF
DxKO9SpE+y3SZUat7izZq0MgCvbO8G8tlBTDZye6ruCF75wdylOR4dXK1geICZD//wEW1yTVOgD8
QnJAbRN9tjI+wIoRy1S8TNpraOjJ92hnFmgUoMLk1NTOKdj/0I2N6O7dXSpaF9ZDmvTJQPSVNiT5
GLYPM6SravQdRPwwfJHtQ1ofmnpjxOt+9nfAwoyjSlf1ec2ANf8tTT5M5X2m/77sZqsb0/lrQsiq
FpU8Iy2FCaqwcv0DbFtmP/YzYIYt3PjWYJafn5yxeobyQVowf1o8PRTdm+TIB3Wz+2j1ID0Zj3CS
O4mmJRDuY6Xl5YkKqn4c0F3lKQRbtuVsHNtLyPj+rPk7e8KxXTh5YhjL7I3zE1IGuvNgmndjfowA
lLQ3lHEuL9baFNKKS7sTPHoLI+/5FJpalaLX6yReWT5Hw7cgpgqxlTfZsPFnG5wsE9KISjb02EB+
m4o0IthoBZLxvjyStQjjZCRiYKpSxxvMCitZqn1UB23ftTu5HxJX0Tb20JpDkFAE4aMjwkvH1Pmc
AYDQEaOnpgfGIKgPGfWJ6WuH+mhn3A7+8fKwVifvxJiwm5TUMMdewdjgD3szeI5pBK7775eNrM7d
iZHlI05WyOcgIjjDiMXto/b3mXlAFRtJw60Tb3U0FJfhtTCWRj7B3ew2D1Ai5yYtwY0UP8Z+cCf0
ng1lX1fq3g5fUsqlCnqsc+519W7SHsPxW71FOLo63L9f8Yck4mS4gKj6SCr5ijyms+XbaNxoKHNv
8SyuWYEpmbAeygUeMIKbOA5XqZkAxYf2R092jv0gjTt7K4u6NqNEucvrm7q94QgzakLj1iBSmHpN
gAKT89oAFx3iDWjFn1SseCrB/gP7AI+GRU3g3EEm+AdkZ7GiyNQPu7RaZCzSwr5KoHJD+xK9Osoh
c1rvg8Tu7m17LvdyPEzF/WhaDXRWdmpXvwaJbj0gcEXgqN4ch8j9Bqn6S25SNMUA2AKHK4xcrg5Q
5BcovdtZ2971vTbKxzQzRgKEWi/1na7lwRax9eo0QpBIs+AC+BQb06sQEeupAY8tVc7DEKmeQut2
GyT7f7/RSCD9Y0aIj9MGIaXWZB4nX+tdbUBI0SpcmDce4y69+t9sCZ6hJ6TcpR5bff5qp7d5cp+W
D90WkHU1iCFygh+K5Jj2LkUbIDHXaCyhZxrxrw46jEruXCQ1eTjrbhbWT9Ay7gqY9Oot0OfaBoMs
baEit/B+kbMizVVF6iLWrFLUXe7vMwWIDBRq/5Y8cwnTyLMwSJoXeSQJV3JZKlDiW4ywqoPuUMbW
77Q09I0H8looDCu4TUoFS4Doz3eY3+mhBBad92LR3EaAdIM83Li3VucLtYeFMwz2BTGHafZhV80z
/YpIIie7cXyrldo1Rxr6x2qrC3NtOAh1AfKgo498jTBnyDAV1TRxoySIiNnFc58+XfbuVQMLW7QO
3RS8DkLkbju9IaUpgzEW0G93Hbc//hsD1M9RKeT8FlsgnSAeA0enBRJewZ9kuhA6C7f0I95VlBbX
QpSARD9rD7m9sOpFrWZVHaP9Njb+UYn2jkoyINshhqoZn4N4EfG5WzRxoXj7b0b317AQVvRlQHts
SsulVeXf6Evz9EDdAJ2sudvp2IQ7Q2lSlL9Dxhaor/D07LRxL9nGYTI2IqTlHBPvJtDmlBGhM+aN
LngCpRLLjmeAK7Wl+Ahn/Rhr8h3Dl7qPn5wxMKGeTu9kWAMuz+Dq8AAwQY0HoZQjdjNnpqO3fo/Z
qYchTKm0XRJbSNVrn3Pp52VT627C3U4nqkmHnViXhRI9y82lF6svNc/076zicTKhxbtWtV9FdWUY
z5L60eo3LpBlj76b2IVZgrQrZNQiLk+HfJZAjhGaCH+qoHPynxX4Xjs56sPh8ghXdzNSYhwVJAdB
q5yffoXeh1alYqpqeWU1Sn3lB/FW3XTLiPDchtMn55LHCGxunwdf/mjBBH15HKtTxrmH9NYSX4oy
YtJkOUg+cipNUverCqLrEsJcsNFX9vBW1VudzGsPESgS/7EmDEiTeWsPBTsM5XECabnbk/l0kX2D
FeSL3zsPivHl8vhW05o0eQEUBwZDV8kyASehMxKNUhZJmETD6XmYMw/VwE+oBH/OZSTy6C8xcpRj
8xLJHe2r5kw7tdN3nV3uLSTSL3/L+lz//RQhlvL7eErTiiPMMQavkoiiHhCx7Yx2n44bplYmGuAI
rXoLWIGXsuCeDdLl6NbiOWgz7coGyfBdaFyZVrYL7DcEkC8PbMuasKxRZ7c9cqnsO97L5vypCr6O
gUoBgieTc2PmV5fNrRxkdESaDAyyIi4hIU5sytqY1YHGPfAgR9JvnfTTaD+glrxxYK6c04hy0FxA
/EtDvMgeo4+1FNXZ0lRHsaz+aA6wWdzk+pWSor+l8nouN9K2a/OokLJVl14kCGiFgdlZByLc59RM
56ex8sJ8vFX3aNTv+7bZaLNc8UWIUUlEoy0EIYjI3idLZh3ISztng0DzyB3lIvWHj2SB6yfWk/mv
8WgEDhhctIwg7qIYJ4xtDorRT5D/9GIY7TvJdlsqCwP77N/7xokZUS+jbtTSaBczPiF23NyXjeeX
Kn1LG+f/2g2HDIxDNYz+ceBkwg6rHKNry5nGzrmsQd1CUQzbTq5Wt1OqP0tjEz3b0aT98CuzPUw5
DexhbHahq4eIUG9svzU/ZWYpyrGU7AnhUxBiVhAhVbkmxrdIfoOCM50XXPSNQX+507jRVg5u1U9P
DAr7fW78KipMDBbQlHQpwuaf0B921SL2huxNCTf2+9qLDazx3wEKQacU2mrWIhHEE/yutBuwNS3M
L0ucC2/kQZI5sCnbONW3y760Nczlej65OsBBZWMfMkzatp6rgoMmND8XoX2UnPmpQgduyDehostQ
hBDmbKhCDGr4o681uZZ6pfprLPcj+s36deDcWc61pT867acuO1RGinD79eBvPLdWzwQb6hYgI4uu
qHBVdkM7F0HBNLdyAEHBVWtph972ZHqPhi22kXeYoT/nAe9T1IHocKe59nxyk2D0eylicjWzlElR
R81+GCaAIpme0bLh/9CDuKS3dlBvYBp8kRDh3g0WytAkgB0u8TC7vrzaa6Oneo5AErVlnmnCAeUM
6AgYuc7M+zYSBhBkxce4OdhScqyy+XjZ2DuczDL8E2tiRq+ItaAtI4P8VP7YKciuV3UFqvuZw8sL
C303ZPEur9X7KjyUyk71rGsz+ljGdxzS6K4juhA/jTtpp8QbH7YScvJdSzl6EZCAhPJ8WSQkuEip
MQsj5cmkKh+5GjYmeu36BqtJXy1vVRuWkXMTTuKHtdQuuzmJrGQ39QlQoMkartGYrCJUlZ325fJs
rx4gpyaXTzrZyXrXJiqhJ3HnQghYfeu7T+a8HxTK619GxIARDZReL9tcnUj2EJOFP+kicSgEikES
14wyHRzUHJu7wd/C3a1OJPqr5JN4jTsimEnxlWQGioEOe3Mnp7fW+EFSj87wfHkgq/uCN79BGVlB
sk9YLrvQ6sosln0R5E+JJt1UYfUy2bAdd91DiGT8ZXOr84bChwk/kMbLSjAnt8HQZuCfPa2rmtvG
LJw7c96iS1h+iXjK4oH/GBH8oYxJDIY9Rgxj3DlJhaxIsqvUjftj3e1ghqQ6zm7HEc7dLiXuyuME
VoRez57rQaGfsryOhvBKgk14TvSrrnRuB+OX5WyFBP/B9CJksDAgamJ7rImSEXLHDjFyp+3a6FWR
UJer1UMf+t7YZcfMeBuK8RgoW+WfNadcmLGARsJVZYgF6r6iSGznQPjmqI4fu6AhvynPyX3VKwio
Bm2z8dJZW0qSuOCfgAXRCygcWORsDQmkFckUKBb97nrmdgh/XfbJ1WDv1MjitKfnxzg38hBipJcc
xx1LCM4DaZ8aTG28iC2Px5kMWB47z6PlIOwR/fwfP0DYFQXVPSnN+IBAyg56frTm18B/0Kdj2wT7
rn5W5Y+29ptq8mW7a5vxdNzCPmnqVrMzjcU04gKdhqNtjrvLFtZirIXKgyMSSCYvn/OZrQMl0Jpm
YrvDA6spe6X/FEtHXbrqoEFO6SG9bG7NO0kOIUq7YAHJ3ZybM2YfmtuQI1NR7hRn8OIWno74rZCi
/WVDazN3akgIkZvSyAMwK5Dvl/lLN+cftXzeGMua51ORXDDI3NXvaPYi3U81uyeCCtuvNvnk6in/
bx72pyaWUZ74vSG3aZX9eVkMn7gtLXrSeVN6XeC11VO1xR29ujgnAxKc3EkcuYp8FmdKbpS6R+YC
Ajo7dsetIGfLkODWoxSrXZ8wc7F/o9if+vS+bj5Y4Uacs7Y+pImpgdCY8p68aYxnezZ9mz2b2oXb
S69lWV0NQb5xP695mgkcEzFdlT/iQ9QPZWPWLY4GO4nR5vaVjm4KJf502Z/X8mh/BKoXrnUIRMWC
qtzGVt4hwIjuiPTWVdpRlTTabGRvgmZ2GEM4WL9rcCBXU31wumAfsKXsMvDSzt7w+9XTGOEB2PJh
mTfQYz73Sq00B4p7GUf+3NKmHvWjm4zUY/UCbH2BPrvjFVFFy3zk0q3jFfNWr/RyKInhw+kHCNvC
dKo0s/Il30XYkHeHxLrNUcIDIRBk8r4rCt5L3uX5X3PZU5PC3jD8IQ7KgNq8U4+HqP3eRMdi0HZz
+/2ynTXIHev8d3KFvWHkzhRZC2HiZIwRfOe5Ww5wW1r1TdBCckZr1M5qv2tzchyGfB+rEeQ8/7qL
ZnkdnX6EEDjpCBXYwzLBTea7qUr6Ho1M+9ds/KjM71N4j1aLl+jHpvsvEnDI9P3RA12KtMIs29oU
JhTrOVKV+CqwUIIq/Ds1fmntXWx+j/vd5cleC61PzQlzXRVEZRLFHi8I5y/5VO173aQPnuzikodT
/q0i759ZXRQBOSZ0Anlh30RtFDt2A7UjKle7qdoV5cMsQ7ezRQGzOiwedhq150UhRbATRnPR6RF2
quxl2RR9dRyVYGdX9/ZWGmHVFKR0C9k0mDDxPi/rLDTruOIokBV0/q40aZchCOB/i/6t/PsyeUs5
i0Zek+yzWB+OJntsQdcTObT71oBQ5rlPHmVz8Czlrmk3dvva1XFqbImaTu5dJUrKILQwlvdNfuxj
RUZsT4dmrUMb+7IPbpkSArAkmSs9UzClDQ/W9COVnojWN2ysHV4wpxHhqRBDA1YRhtNQVy1iHKLs
KjfpCg+8iYvEkuv8V6M5sSSEXXTZOLNTYCloaQLV6C3zH/r+9fKUrR3/p8MR/Duuel0ucowYekTX
8YemilzFOCrKx2yq3GZ8rKr9ZYurE4j4IWo75JrfMXVx2QRIjJGtH8MHvTiU8nWUfoRz73+zInjd
BKi6GyuslDkieEogvc3pfBMp6mMa+luX+LISwh26kNbzYmM8HEjCURuCkVBim/w5JKH7mra4AWI9
s0rdDgq0VLrWES3l+jFuAhpFfVXxDLve+IaVtwefAMsEfBakscQtPZYAPsrlE2BdU619X+9K47qH
P1C2fvSb6LqVo2opPwL9J7EGvbGw0dRmLJp5eRFkRg+7k3RAvu6jbo5XtAPcZoG51cCyBCHiBDOx
dMssFVeQn+ebblbqsdM0VhNQ334w7T0Z+sv+snJ0LBC7RaAcanxYdM8t5E2TTrVGfSyU3srgIZtG
N043ctJbNgSf1NNItrIKG/MAfZb9lljSnWKPh8sjWdlfZyMR1maIEkMLSjyhjgu6+720uo60FwUu
qv/FDtz15zM2w/6rQPYOx7beu4X8CCCii0tvGyS9LK64+OQEyK7zt4Xp/9yQSpWx0mqe1XMNsMrt
6qlMILdTnJ0kZQ1J9CI31H3WVc7eJyd+HQ7jcI1YqHM32iXflyK6vZvtajjOYRgfsNH9oglHjtw6
rHK4Nh0fMcA6Ju0YjTN0zdmUAPdt2WvWVUf9AvRR0Wj7JC1V15Dm8Ys/zPJrHDTBnROV09sYpJb/
nHSq9qp3MOcUoUQWeJCt4GinivnTj5L5yUpVOkIlu8+PZVnmA9ivYIi9eUQ97Fj7rdXfOXUiVQet
SZTwqARB+KU2+uGLVFeaBl9hEb6Wk61ErhT4aKPZrdpfUQ7MD0Ncx87GLbd2nACIAuDHexyUl3DL
zSWXX6aQKPXzdtcax5qgtdSvxuqu1PeZ/eGyK61tjFNr6vkKB3EXTbGKNasaqETToNaGrk1K47KZ
tZ1xakZwpCaZcZoJMwr0edlz4n/oux/VZtlrmRvRXyH0ARdHZAoZp3Ab1L4ROho8jF5T/Si1nZod
Nf0xCRFPKW+l+Ah8yKmeTHPj6bz2kqRN/K/ZZfQncdbQoorFK4C8nvazh2yoyD6kKNGY/d4welfW
Hxtp30KLsIXnfse6RzS50PWqHJoUnABrnhu2q7mVgGNlHip2P/Tibe7HA6CooP/UJc2NGUx7m2fA
IjUy0maTGM9coNdzWNxMmnW8vMIr99LZpwhz0NZ2SjWGT9EHxYQG2dhJRglkuQ28rkiu1WKL5Wcl
fGLg3EsLcFS2RIoE3/TzSM+GzEsL86VIkaGxy8QzMv+hk4rfVBWumql5KXX75+WBrmHCTw2LFAlG
piSDpPRIpBXztS+nhDh2ZnmtpLf3stlDUlLmSXwbz41V3CSh5N/KVhrRVVs24W9/0mTJaxNTIaWe
9U+yOsVXcWYjbKlDRafS9e+3r2FijJ/7gGq8G+thdRMOvXEzyXL6JMdcw3lQbKBK11yYWJQyD/At
AwlMwZPiYG7asB/BNUl97/lg2WW7MTgV9Fe0WZJ9XScfycM8GelxrhLNVcYt6Y2VkwgECZi7BXEE
skM4IkAzzpIWyRlhQPZF08Kj01ifTWULqbZyEiGeuqR8yDEQCIvH6xCPplGxetMwuyaVDDreuvCY
Aaq47CfvmvaXzUkJQ1FB4cgLdOx8czbKQB3MnjKvUl9HnpU6bOq7Wtll800vf4IQD07IMLzSqtFN
6WGQtcc0ug6DK1nzVP7b5a95P7tLmpo3OwRc3C2mEADJaTxL+M+CVs/AsF11U+6l478+5aEiNpA4
AiuON4nENl3YW9oIrACFETK80W403lT187jVM/o+JD03Ixw1hCpa1RSYyWA7GPSHyUk2Zuv9YbZY
IMY2IeiB1lgISY10ipTMwEKhdftJ/pTPO9D8x3SGler68sKsDUZb9MJ1mCQQQhdiRtOcfVYGjlLE
7NqnNo8o8bZZtjGgFWekDqqBQ8MIaDdR6sgKDAuVL8yY0ycDSdRQyT47Q05TSvriNKDuadBJpR5R
6xq+kUUBM3BbI3pp1Re9i+995eNolZ6kbfaCvr+yl6Yok+INEj+wzgsHDzU+Ta/lKvOC3EGSVYOR
LrLmR9K1LrQv+3KG5Gf6PvbZIW2AQRkvl6d/pcJ5bl9wpjiQjN5s64xShHPoq96tJgkdWSV8mP3f
dRMdJkmnLYugftxKpK15GUUkbq9FEZJ9c35AFAVglDlvWBPerVF/r2a7JVbxx9s52aryvD/2GOZf
WyJQJBroAw4jbGlzC2wW+pTxVotu7S1M1+qYaHKjYrHQkYvJQaj3SDCbhAG0MLmKXNARc+imh7R9
y6XjxtKtus6JrWVrnYRdY683XWJhixckIfIvWSFEvjL9wtOt7zNZ5kg/FGCPxo+XDa+MkfcQODLO
B8hGxBqG6thRY+lFDkrtd5BLrppzUdI1GN9Ym9Irq7Z46+Me5A3563yM0lBnedyVSCKrDUWzo6oe
5RJq96Zz239f1QTdDJITKwbYUTGaLNupUoOpwlZzNJX7GRXqZlTcuduYv5Ui0LkhYc+V2lSb6Yih
LrtNwvu5PI7aT9Xej2Qqrc7t81sKH7L6uSiu7WbfJc+X1+995Ih5nYIatzO0hmLCJjecNCA2zD3f
GIBB0QCPwvSwFCWtl7wpPSi+k61mjZX9d2ZTuH81jnk107E56+nBiQ9K5l9Z2o3RbpW1tgYnHCqo
ohlxOdJzpqG8CaEjg5rcLvmhGP6u1Xsvkg+R/Xp5Qt8/Wc8mVBfyEcQcE2IiDC63SHzdtM1u1t/m
RufN7Y1xff3vrXGRoZpGGEP39rJlTrb9NMo9LS4K7/Ai2ms07ib1nUS6LanGQ9UN4Cq6jdtzbROe
WhQWzzC6CKFk9D4lpTw24zcpoy3ZNg9RmLnSZhS1ak3lQUnNYyFiE7Y8WLc4TGrG147FbsotSGoA
+U/FTg1osdl8M//plD1/NJNQRwGRuJ93syLK+c1JG85Kh6apo9IGDZ9/UVv2YZjSBsbPEjG345Sk
zi1kxBBUJ3WofFYyAHa2VOrXqexb0cM8BPZvPymU32OTFzdSZAbXUzpZB7Sno492MIBAbYq0fpnn
eTxaeVU+yRKSd+ak6l/zoaqPhVPqCbJ+pe97KO3Kb9HYRm+mEsMVM5SS+YUMZL7QPOeq7KrjWPW7
Kk0QwKoiu9eO5iDpL0MSd85j4uRFzD265JwDrS/7ayfI4O3Pktj+qna2lEOlrPb1vkunuYM4KnN+
lYUPKr8NjKDY+76ka3tnkpXxWCdybHlTQ9IPDg4khvd5X5XVIaigLr6WLL23P6hO2ESuHynjeK37
mWV5Ud9kyY1MLZ2J64IKEKY2HuNQd9pHP0qD9tpMq+CqdcwJE86YvYZ0ED8OFclRdxpsSGNyO228
WbUnf1faEsVRONjoTjdsFIKHOUARNs3S0Tpmmu7vfbUOQy8fAusuLiqr8HAqi3DF73neGFySUMWk
+vSznRfRv7Q06UQre3iJnsLBV9rrKZZb2Hlyy6ndSJrSl2JwzEdVLcdoPwI5v1cnyR9dI0xH5A8q
R+pdM9Lz114zIphunHIwvGmelQMAHO07KQDTfk5hVK8PbRjzwUbTtHt9BrVziFOZmLNNwvLRmvW8
+zgXY9F5mVPm1d6xMqe5bstW/i4r3XSU/RCND2OKA3JwdWwNt3Vc26+hHiByGUOXfJTnZqJYR8vF
J/LUUeXFWdE+90MJP11XgHR1WgtGJ0uV8h9DaQw/+9CsvhbTIN/rPMmvKiOwbjspyYCfB71l7WCb
szM3lM352klL6WPiNNkHZ+yrbgeo2NppWVjd6l0QB7DRWepLmWb1wa/Uad63U0EzdzMEyedCqaun
utBS0/Wdobmy455Wxoa2Rmgq597/ZmTR+KOopMb2qKTOR0r9MizpFl0iu3h0TLp5YgjmKHzS2Ies
VP4tm+Pkyowl7XOldI6xS22/+EW6q9E9+nKh5g2LbKZPfLC+BaGhzmCg/OI5qo3yWNuGWu2V0LIe
Kyj1UO9I5Dl2+8gh59DJgRXsUQIbSNNofvzNlhS1O9Ydrol3czslZpcPh8EIF2iEEuX3adb6A8o2
6dC6sxxQ6zB5i91LYzLJh5zN+t2clCRwk6xXyo0H5ruLBqYazbA1QJC83HnJnh/9/qAOfdcpEgAN
D8nChRgxNFUvlu/t+Jlsz+WL5t3TbLGGeiGQQN7M72LZMDLyJvWxJjnfmozeSv3tsoF3dzUG6LOA
9ggFWt6A6vlw+qKxkIBDZCQHKU+JpW8fmuJzPKH8iLxK1lyVwxZ1zJZJYQbTbCCXpHKhBNNbCjgB
5vsCr0yBh3/rbcNztqgv3iUehDEKQbrazW2fU25xx/HBVg+aWpAZOF6ex3fBlWBDeEP6czBnVoiN
kCDODw7OAAviuKv0jchjzSFIG5FqpVKBSwiRB0B8qPEj7NTlx1TLvLrccIj1yfprQAg0zKSd5qxY
DIwvpBQV5XmTPnFrDIuDnERPrTFpcdJiwg6DA9JE7qxv+diGCbF5qlBi0rLLNDWh6erBZ9nZWIf1
aaLhQ10SJvQ/n4/BH1WzR6idMcSNC418XX9QzQ+Xfeo9gmlxKhucAU0stDqLi623EK0CmVzk9pJd
UMHCVe9m57bvvFi3XNN6DKXarTq4P5udXG149OoU0mcKvBS+GCgnz0eoBImZIA8huZZ/X2WPdrNR
D13dMSe/X3C0oO/7uMv4/dJEn7jW7yfblef7dKtZfGscgrdVphYY07L7izp1M+XKl7cwLu8TOKzT
gtu2lhZxGhiEzU8L/DgPI+s0wkNtGv+PtPNqkhtXsvAvYgS9eWXZ9k5qmRdGSzOi956/fj9q415V
obnFUG/EPE2HKgkgASQy85wDTNX1o/tK22jjVWFsI+++/Ov662ySzgKdPkkOA03wP7Mum7IjwEMc
6r6R3VH5pNO9WBrHyy64NHmnZgQnSEPCuFDFjKx+syB0Mrt/LxtY8AIgHxRxdcontIMIBtShCFAs
AnxX1p8VCijldtSvBuf1spWF3YoVvHjuWoCsR3jPaNGMw6gmyU30XUZFI6hiKsnBSmiwMFmkLkyE
Ckja0hAieBokopbWZqhjRs5nx3qSgxV+snejID+LcAfwFQNSbkoH5zsymFnA6VsNNrp0H/c3sbnT
vL9db0wwPzMhGdwbzm+hvZOjufMBzlR9FhDSAcR51rWV35+X8+yhN/8+eVZkzgzTotvifAhSJ/th
2ufBptF+KdVL31z3ARHbNghXDL3zK8GQMFe+4+FzfoH4Vz4Bjr8Ore96spOrv11ytFSgcKM/kLY9
3smC+2ppJqdV1kNCof5qwm3brfW+LIzjzIB9PmFpEynmCNBmY1gPk7cHK1jQ67hWG19YFkpeLLdB
EYCHuOC5sUeUbzSzlfIu8dBJV49Nl2+QoBnWjuMFJz41ZYqJmsHJNWXAFCR7en5o6+vOXrlZlkZD
1KyRXZvR7uJxnOSB3reNxqLoP/XCtbMbrwYYRWUhXvGydzue5T+1NK/eyXbJVJMHrYmlHCHEKKNS
usZNtDBd5AhZFJq6qLKL9aym77tYr41gk/LciD/r5i6qVgqvCy6GCXAXULnOLGaCD4PI8OzGg0gl
0f61dZfnlFtGzzmayJcP4UU7YPTnfgFuLUvY+7bdO7lVOMFGkraRton8rWk/TGsoqoUloVhGayFq
qKoGHOd8SdpQU0NzasMNym2K9ClMP18exdrvC0veqW0WpAq/X8T7On1sil+Xf//9LFH/JrWo/36P
vTuBw6B3tLry6XeK1OboeM29rU/kJHJauMohWGthWDQ3t/jQyQcThbj4HNXD5ESwppTjzqxzeDX3
Ibvel1YOyvd7kuIfyEGGxoZUxVC2Tib0B1svBtn/oAQ13TH7vnhs1Xpf9G+XZ3A+rM7vGEyhbmZS
yqeJSawzxqVBw4KOKTQSnac4k4enPqlvpjGujnlXhxt17H9o9TjcxORALtt+7x0KpGhMI0RBaBWI
vaC9rw1SZTOdMGRtPCvb1WvQovnAF0enc3cRCtDvSUH13L/9qDSTzJxZYIx2Z0mG61jNTVyEXxpr
3HRU1iwyVh8YFG9NamkcEAzt3GSktWEAwQaAmfIxsgu3WWvcWVoxbk/oJ6jZk4kQDHSWmka/kRpG
icpThMjJdnAeaR2SIzKlPSms7eURvT9VyeHMXUucQqCNdSEe7NKocuySvmcve5worJdP7doL9P3j
bS49ctbBQKBD3yK+nwo1bwt79KEqDb9Y3kaGULk7Dj4y0z7cxo8d+PcSNQ0T4c76cHl47zf1uWkh
aCiaQUHjG9OqNVwNCvBwE/6F5+mve9TPh2gJySMlafqhUQLohu3ENeMvQVbsm7Ua63vnOBuMeG1U
XthHc05zMym0UdNLBjHKc+0MLsJMr76CLmfVk/R0Vg6s9y6C2TkkgiKOrmPxHin6mhylzti8BD6Q
6FDlr95fV+Tm+SN7wJ0L+9b7RurS76RutlE6ZnfsDedfYPAPjTQWR+KO/WWnWBzQH2OiZkXnaDGx
CsYC7V9D3k0cE76+4njvX8LnIxIbjqzA4ImsYUSXbj1925m3ESTmWartK/W6VnZT8VOVvl4e2KK3
nwxM8MIgmpxR8bDphGq2rZLozuhGnYdxLu2AG69BndbmUTiAU9nLBitHh0jWngLvsexoLlwBb62Z
mG+Zk7AycKJgsvyQpbJ/EJHRoeFa/kro+l6tYV6qmfGetrC5i3r+iBMjQC0NvTcYh+HcSUiUlne5
7jatO2hHL7kywk8W0p++7CJYXxoPegJuzFWblSft+6Y/4SvmxT35CifTCggz+IoBAUjNVYPBVaH2
jt+C4SFFcrr3tibynN3a8bzoNCejF4LeoEKBqqixO0Yvqom+zxE6/C31msu+ubghMOPQjTKXUsV2
4HpqoWLxsCPp5Ol0xqGYMOx5lFI9UAbB3JsnK1up1q7ha71s/H3MBX6I1jFa7myba0h41YFANkZF
xXZc2te6JW0TUl/9oH03c+vKb9ccar40zyOTU3O6CAkYLLvMRxVNsoT4zvq3GJSt77l6/VyAfK6y
ahvk+zTrr/pg5TZfWss/42S2z33IDOV6VH0MZ0ivlZp55YfV3lJp8IbL9fKULt7qOjo4vC6JL9/d
6klbD20WYsumHON22uTa7YS0R7IdKYEZxbCb/39Va/exkhz5VrAHK4Rni3vm9BuE650GgyZLer5B
siLvEyna/iY1Mx5VU95tMhmWnV7ypwOEeeN1EarVQzpUh4b31wrL6P8xGYBm/rdIJT5OFSTQSIzw
IbJJz1iz7dpjZP2Umn1s7H3dzeFY6Jkkkm3D2vE1H4HvnE0j4wr959xUKKx5qUUh5Gw5R6Q/3mtS
CT7DW4kAFt0KZIvBe1KfOWLP3UodHSeF1p5pDr9DvBlr/zgzU8aKlaWzHtAWIkSU8Om3EK6TSBo0
KS+qOc4wrlszPwYtCLLxx4rfLs0XyDAOIYtuo3ciJ1ZShIodzSFhxxE7ePZrZknp3O4gb7w2UT97
8I9FTerReN3/GIr8a11bT6XuwVCVap+9RtdWTqfFoxGmVuBq5M3IPghHcJdIXEwVfSxxne48zXum
6fLYTCXajWjKeeGT3qY7Y0h3frISMfxOy4newyONhDCuO/fZCksbI4qgwXO3iYvHyhwOYaX/SMbY
TZvnSWm2ih/8i/LMnMftqON1xbcm4hbqK/WqNmICNdU1nW+XV2jetOInsS42eV2T/0TMzWjVZUkB
f34gowLVPaXaeICWxfW84T4Hk+/Fa8w6S/59alGImwqEZ8ZxwmIRTSX6hfq2lpNvIXkTY7XFZ8nL
T20JXq5IzTSoPbZiommnD12reC36lRto6b47NTLvgZNYojKkoFYcjIwcwVFUuqEPwd21F/D42V1e
raVHyakpwYHypGkDaFjjTU2zcJ3tED60wu9e7G9VdO9Gv3WLduXYXzaJ7AUt/ZxGYo9U1Bdh3JmM
TvZKLEWbKlavRkd2W9O590y4BNOHWJpW5AeWzg1L/40Vh08Gls3zOZXSyhgDhUNQ08EHWPZ96K/F
SEvLNo8HvNScgxI7KvJCDiFeb7i+TWssHtOx6+lC5sAwtmFSwGzjN8gH13QLrVzmS06JhhUqEWTw
eakLB1BVpNykcodsyfgQa/sGqbL+I5cIBIRcIY6uUxoSYjC5GfosNHqEWts3abr3g8+h89m095fd
cXEkUGOpVAVtqsXCbThZw5hwk+AbdvjStt1rVAGh66cVr1+88OlEsaCoIhf9Dk8CVtLz5WEkxHPu
jGBnxjd9th8rmnUeZWOXKzuNN4J5q3SfPjC+E7vCURUMShv0wTQfH9neiaMrrXzOU2llFpeO4NPR
Cb4e+eHkp7OCWmDpxabSrH9no0eHTrONWmTWPixaZVtm2UrLxbJdmnwo7sF6I+5so89KrabWD9FY
uglT+6azzO04SQ+elLmZIu1N89fl+Vza1Wzm/1gUu2W9Jg07DRQs6Fl/Y0f3TrvWyL14u5+aEFyS
x41emj4mbNuDLYGdtQv8R7//UpgbyksqKotes7Khl47I38gfhXIyTBrCZvOMwqinyMBNOkrJxjdY
TTdD3G81uprCarhu9PRW7sery5O5YlWcTLo0hhjIJSMdHqYCNZFHNXitpMdaP1blplzr2Fra6yeD
FHOXjua0MSAY2n8jMIc3gQYoOvjATji1Iew3dEZz01exocc1Yq6uoQeuSka7Grdjg0bmirm1IQkb
b0zteCxlzFnBWwIQJRt2q8JDv68RIcAycfi5+j/364hlAS32m7LmDt20cJeHe0Xt/G+okZo/Q1AG
eydXspcht+N7a2iqaTNWvvRAdZeyWB/7/W1QJslNY9hwyl/2noWxz5zcKgKkEDCTLT6/YO0MEHnD
65UEzJXnX9fW4NrdKkfFXFUVBz+/znmwwvriiDgfxHFpBu3IkfV9adxKdqk++qlxkww9T7bKOYyd
2m8JX+4GqN3dIMqnlWEunDgziw6oVdgwAOoLxwH9mUCDLIL9SQNgCkMel8XliVw6cTCBxiJMGAbN
ccJ17k+l1xg+MVlu3jjNcah3dr5JrG96IAM5PAw9j+GVSvPS4lFjhBp1Zjp/R/GZmFra6PkccUq3
iXmQiDtBzF8e18LxYp7aMM8dpFJkOpaajLO63MKeM/jbKb3zws8w58Ir0n4glEB3ghIkOLg50hRm
kQZq32w13qOhcq0H18Xw3Q5XYsrFWaOrlacfng8G9nxEaamHQTBhwlZw+Z99ejc2K49LOOMWPH6O
k2eedurAIlNPEw3VGCOXAKQwLD/PmrU/DDnuXlG2KmAr9dTvSZ05V14YSfdWFjXXUaqkuwgE29HL
5eDKj6rmmz548lsZ5d5RVvxpH0mGz6vCzLVD3vneHmmA9ppO7U53JyubvsUjJIymPySh2w26XMCF
bFfbdIzauyZM5O1Ym8UmrFv1rh4t6aEqvaFBwGucDqVS+m9qpCR3ZtoWT15RD7d6FDaPiVS1vDaD
AjLOOHVgTGtrf+vL6g97iuHTz/TaU5GuLJpPbRuGO73pwnvDqox6GxohnHEFFVL4RgIL+tIJna3X
xoRvjInrn7ti8q8Uo1R2jkeg47atrR+DYsgLUs5ldRtq2vxlXnTVITW0Vcs2Q95cD+BzdvJ+X5pG
tZez3kkPQAzaI1nG/gowQ+hv5CnQPvvJZF/3Zj1AQzNkWrjz9GQsXD2V9Vu1kL2j3zt0dBe1XNdu
yyTue/QDtwZ9WoCVzVQ6dm0SwitgdM4+MrvwkE6O+TVtgvSa7KP0KaK/+/vk2d5DXfT6TlICrQVc
pGuJG1IN1bdoRuv0Fcqx8kWbVIey9mDeJGmrvLVJpf6r56H82FtJtMtpKydgBh+VbKUsT76ksdmX
UM7nyT+ZZwzXEdobr5HSdVd5pkw0uY/pHf+8vQtsG5RMYml3njQqFFa04Moe1OhODY1yW+VTWLgl
6d4vTqmaT33mOxEq7ZVWgBa0k37vpb6fHGC9UK9ytW6e4kgr90BonWYTadp4TcNX/93qAplab0Wy
2EaI/dCD5K1cHdLtRxsc2X3ilVGBQMV8hiO78+LHafacZ5OZb6MiKK7avCy/+boZOG6pVP2b3kU0
jibKOBnXapA0XyP6I/fRlBTXXitrn7K20LwrFKpDyEvV6UnptQz0ymhsJE+yngyr9K4apTbkQ6d7
mr8r29JTXDMj77rRo3jsDkldD09J0Y2dOySOd9sbUgosUmqPXlhI4CGGMv8BqjD4pDEvgVtCpP3i
K0adbTOrSz7lkT68qLA/fncKiK79xJEbNyqi7FOmdeWbkZBRAPRogg4I4qD8kveJ8+Q5fm2CF9I0
ZBn09MbuB383tRBSJHndf1LLUa1cX6ryX0PXDzuFguIn1QxB3yU2xSI3VXOI6tPQCV602EOfMDSC
3vUJzj+poyrtc6/VAlfO5YSef2/oX7XK7688ABiOm/WmedMXqnfvaw0bOJeNgV1EM2OQFt1N38fy
t5HOJ1eNS51PB0eTQhieW/dpxQMbdi9juCq9UOLoMKt4RHR0qq71Soofx2hqcxc9rPKqtM14nxkN
+TJjCiqyD8YA8CyK/6Gvq/9cWE57ldqJQ2GbJOBDxhstA04ZbIsqr9582wvuOQ3brVSl4w8rVcv9
pEM0p3XZELi1VcAZNI2jfxN2IaGrM5reodSj9GXguN7LUa12Lob8K7BS5Z5Gj/hOL/LoWfLG4GgG
msF2iCFwsc2g2fkaoh8AnLo9tJXxN4A1kquPQbuDYMc6wo8D2aXpG922qkaLpJ+i0hMCx7O/10cL
1Vq97HdhlOm7vIuN/lCYZuVs7FQ3JhfOg9pxe6gxm60a1EnAo6yiOmwUsEi7HbyHO9hIGm1jgdPZ
mUqcfLIjjRRJVg/SxBFmVOMGcOBUbBy5jn+hZAHwe8jL5rXMHW83alXxzdK95tgFSbyHNKb+pvlS
A1oHcFUltc2usqpiq82THmTS9EVXWvlXr8e2a1lx/kRjgHXrN059g5LPdKXgiMgdSMGaDs9SKQAa
0z+3nBA9BoCl0BoE4dRpz1O4l6lFKNY31fkiU0+ezI1UuPG419fUjxajubldcOY9IZksmK3ogcqV
uZYs1YcSwYqkWmusXIx6TizMX3CSy/PbQvXh0aGo247fC+WfWQfEAaFkaiSEwp9OkjzqzRpDxWII
qcuwRjjkymkgm1/qJ1bL2oraQSJoiOfWx/DK6PZtGrpIp4XBcQi/ePo/UbnyFl8KVMjqWXQqklMh
5Dq3GdYB7Opz+Tr37sPQ7c19Uxz6+s5be9QthV2nhoQpRXRudLq5qixVn9rqq+ZftWuKqEt+cWpi
/oST+YtKrwrCedUm62pIDUjZtb8vjZskuHjJ0eM1M7OfW8hpZNPVuf7m9Df9eLCcnWOs1KTngFp8
KyHjAeIdhhbzXRu3Uqe1rHRzyXayb3s7uW7CGGHcEKlrdXs5tl9akhNTYk9GZVl1kSaMxrNfbP0R
UVdlrbX3Pe0GJMenNoSXF/jTKXMCbECauoEkkxARVt9J3lpeBSWUdKvSWRh0JuI64Jg1Z0NU5cqZ
4sbRcBwREB14sTXyd4smgcujX5losX3ItuLSq+dOisrfOdpr35JZuPbXmqGWfNKgiYfnJaJwPA3P
PcbskhpWGl6eavUrrj4F1ecPjGLOvMJogkqGKNVHFFR7Y81rJnV2Zek2oExgpLWztQ7KRV/hiKD7
34YdQdTw6tWI5EXM81bzrlXp37KDXm6lxLBmQjghZGMso37ARGu/OF0IRGIrrym6rtmY/35yRORx
1dm6zZPZzn+V8S7OH4bi+SMr8mem3r2YYRwreoZREK6Vxhc7/+6lm75aqx8setbJighP5VBRA980
sJMhUKV9jrqVvPDaVAm3kVTyQPJ0pqpMdyVqqLXxqvy1fsh8OpyMQThPo1iF9rJgDE19HbVfKucl
9p4uL8fKNP2+dE9W3PEyusErTIC0DxK0gaoP3AmzLg2dqeTrCMHOXWqUW3C/KTWqVLkOUTrlxpb/
WlFqnifCNmB4UE47YpleBgJfOg27fExpZukfbempNe58GtjNlVNxKR44tSRswpK4OcgAKG1G+aAH
R7+yXd18gqU8//su2HlMJvKiUE7PKZ/zeVOVwiuzCEudAq3B/aTvu/4jaw8mij58cq/0mZ+bqAa0
1RSPQntT3BlO7jbpR/b6HwOGMIYka3LTDubTvfsMSNwMbnLvYK7BlhZ3Ih1UAKTpvWa6zodhyWFW
1u2cg7MOvb+XytiN1i7qpdsQUmRwGJSBIAIX4sC8mIDD9tTWAiDlqb+PzdGFUlCJdpe341IRzzw1
JDgYKvKVnjazobopbkkqxdcZSY2d1dT1I4hPb1N1sFt3pvl9kJV6a07GPjFDbQMV+lrEveTs3Mu/
/ZDqsSoEJ0mjTfmksnWteC+rA3D6Z1++aVA9HJSVrOPSMXRqSqhpZIVaklfB1NzQG2pPPfpBl2d2
2QJMezMaDISbcA5pCVoK0Zw6bepDkd9r3cpmWvQQMvj/+X3hPnAyKAWrgd8vs3+iNtr6GdkSx9pp
4Rrv/W8uLjEG5mkH6IjQkZ5/wRlxRGpaEC5u7M5ES9Pg8SPtDR8aWHJWzWTR6mW5qo90Vpzf0rB8
P5L7m+qWzFjnRrCVa5Cmhb1zbJX71nNIfK3MxdL78PQDBScGndZO7TwXrfTFNh8D8zoNdkGOiPF1
WRy1teaLxak/mQ/hACDnaDhwl1FZpCBWh41rFiPQwqNPguiyEy0dNacDE4KXzImAjowMLKJhUvvc
SPeyvHICLPrprAxBXwJ1C9FPeykzYISg4SJSb4NYIfxeq/4ubus/FkT4fZglTk5PB30CyKok9afa
2mfJ16S+laAXuTxfK4NxhG3tOWbVlyqDCcLimEfhLZJ/x8smlpfkv/MlvtBrTR2HyJs5bMz2kGs9
ebXMTaxkZVnWJk1w6bKLK13xWPkRCDGkGFYGE2C81buXPkpWZm1tSPPfT2KysYD0Fc5Brs1G35r5
59QE222vzNvyHv0zb8J56MlKaDk18+ZHR5km0Kq+G/u70iSAQmJMOTja/vJCLV9tDmByFBpgXxDf
ekU0xr2ut1wn4W2YXnvDQ0Lvsap8gVuphXVMd3VlQyXY5aX4kX07d2aRe9eA7wkzmg1TTH4a00F9
nbXBRibRH6zJPS0u24kRYUY7PRslc965jn2IrEOV1rTkr5TOFjfUiQ3hlimzcDImAxsDfDPZTGrQ
rjjfmgUhKISLqwglCQvMpetJ+aZba6pd9DwKf8C7rN8KMefunSNiZeYpXVeZHX2KOFLdNEVaEtpp
c2PB1wbTzfhM5eSN7q+rD/jgLHwLmlYFpPeu6z7u68huBgqohv+U2hrgnk99XZLLLm672tpkg/xU
DT+m5pW++J0u/TW7MC8VyNQIVGfUsPUuTyAhc1YpjD2NlBjCe2uUj3onGf9AJxXf2naufL484iWn
ZKrR+QbgINOPfT7ZQ9grM28zThm4Soz0RfYw+ePK9lo6HE+NCNcitoew0DESaD9Di4LOMTEKnpKf
6vb18nDmXxJDn1NLwh6D2G30u5bwuBigKYUrDIDRRqVIpDXfLltamzhhp3GTmAmFGOJF5833j1b8
Ylm7yyaWNsKMgIfYFo4QXjDna6OqZVmHPa1lmfdmhch7UX8uqEjKbu+8adK+9H9cNrg8pv8aFJuh
7KSlm7jGoJprO3OgXwHV8JQi6GUzy4v0x4x6Pq4iN5RKzeZFivdmttP1bZa8aPoHDqqT2RMf/UYG
ZXxbYkWrvqbRoStWMs1LB+Hp789/P7mFLYDqAzprPEkG9BvRpo7WbqXF9Z9vQ7gpgLyKz+MuqhP4
KxX6lK2Xqhk30fBayTrFROqgV+FImWgNLLy4Uel3BdIABB+E7fmY/Ca3yFlh0VFuQw88SrTP/N7t
W4W4eX/ZCxbn78SW4AUqfP+GUTF/ARBQyaRnfuUseE8TOx+mJxaEd1Bmj5leDVgo6ciMrovqJfef
K32TlYeWAjGxc3St+HvI+MF1bbJs5UW5GNBYxm9dB3pY3gU0Xg9vZOvhgVKgQN2XWt34WQ8lCs5V
ZOeAo72M0t9QPieWmT6YgKDyzdyDcKeA74NGW/erlTlf3ODANUAqQHTzjqXfUv2+rD2NL+peInVX
99eNs3JorZmYN//JttBSZyzDRKebObLu4xY+tSy6z6o1QvLFvXEyEuGg5/Tt7HDCTN0lzY1h9TnB
iHIdDaG5rY3o2naSADS6f6OX+dorb3GXnNgWzuW+aUOjg290U2s53Er7Kn7JgwO8OMBfPrBH/lgS
WbejqO5sv8JS0Bhupctuo/7/PELc8ZaWW1aVYyHRCUeLvUrDj56ulCYWt/rJMISt7gxKQfsKbtcp
r1DDqsPL5WlaXBBbg7UJfBTdg7NPnvhcFkUodJXUomBHdWUDXv9tBKOk90gR7LKl38VxMcAgsuWd
wMEC7EAYSpwoUaLNQA7oAVxPu+m6X4kHBeK9hHZdk+967Wil30bvrjAeKcldtr40TmJDkE86yl3A
Lc7H6ZlSFqHZzTxG9VsV0Fs+fKe57GEwPmlxvbKRl3YY6FMwTWAT9HcilFCKAr6YG/1UXYbv5yaN
fgya7Rr5JshuunhbN/9eHt2iQahfAHTAz2mIzD8SWsVq4TWkaez8Zqy/1bBV2MN9YPebyfM/Tem4
Rct+ZUqXjisuUVtmUekEFUvSFs8+K1OAkcQ6DHbozHQ34yoP1KIRqL9ot6CHGY7083Vz7KEltchb
utLrfe1NV2UgH2rfXFmxxYYSmN5RbAOURx5TuL6rXp1p/+bXQ5jcjdXDBLl1UNX3sKrt6HXdB2Xw
iM7y8xjVUPq+XV6+pU0OXBn+KcBANknh80GazpSZpUOQXyLWKg23Xf7PZQOLswhdN8UIKsHkUc8N
xKpeDrLGdWp502Gu3BWSvPd9e8Uj5gvq3Q4/MSNcYLKGTLI1xyWqBTxLpUs33bfRi/4B4DNsg3+G
I2xmJVfgoqUPdOMR04X04cTpW6mA31urSS3uqxNDwksltD2zLSDQ2eQqWhjOm04bZ/LS6A+ttc3y
8FjbHyjp2bRxmRwelNVFKr2ibx25KknW+/H1OH2VzaNSfaC6inA6JXsCLEMVry1Jg0knkkjYOFG0
sQZIKrgi1xKhSx59akQ46814gosowwiM1I+y2T452fNll16zIBwMmpalOXqX7Bl0vpThwUhWlmIx
BqV2Z8wINoWzR4hVYnkM/b5iV9b2FzkHK3Qzqi9S+zkKnmCID+6kO5Jp00deeCdWxZdLQOyZGPOD
v48n2mNem8pyC3u7KuExu664V0/tCAeeX8n9AEVUvFFKMzuE6vjUDV+qyXk0p58peD7Xin9cXrGl
Q+jUougTWazlcc5mig2ACbMeSvsc/7XOKg+XUyOCW6RqrfqVx7A65wCLrItyOByk2hol5dJJd2pm
9s6TsCm36l4bLMwUvMCSYXRT80fTHwt5BWix2Jl3akg4ufVRgex8xuahJ73xx7fJY8HuvOIZbVDU
5VDMMFQCqg+U9ID5QsBHUhmkuJgBcCI/qtX5Okw6+brJrPtuVYlkXm7BATHhzISbUFG9E3ryjLwf
6L/HhFXel/MzuZjcMGjdNNJAypQka64tLdv2xtfB/6oWa0wKC0tIRdG0TRAsQFRFEgeza5U0VLlE
ZBiB+vwQ0aUhfzfWCLIXvP7MjHAnAv719djCTNPQBN4MD41e/moyeXt5cy1s5zMzwpXYtFPZhTOW
MqmjO2SjgGW78dNgOXdV7rn0oqxc9Qs3o8U7mCoayNv3tbRIkeQyqrnqI7N81dV8F7S/Ag/cef+C
S9FT/MMJ+8MHxnhiU7iNJV3qjbJR5yNrW00vVfzkuloRulGzUjJfXDPeCcS1iHIAmzvf3UVdpX44
G+pHmDrtYN9N6XU5+Ss8ImtmhPFoQ+VbvYyZoTmU5mNU75PgeHnK5i99t8kQ4+Tpgy4tEdP5SBqv
RBCR5vlN19OrH+6ciiwOIJ3UbT5Qo0Frjx4RaJlnJkrhQnEgByYow9QQ9NvWPGpDiwite3k8i1NG
owi/hhY5FE7n46lTDZiEYZOFAUoHe8dIj6bhr9z8S3tJkWm1JRRn2kRoou8PquSjTQGmQzl4Aanw
SIe0Th+3TucAehlIJIb5ykotjUwBIgh5IqHfO0hd1JsBmBn4L4MGPTinSsut5XT9PtSmleEtHXyn
loQTaZosE2ACwwscJCxa/TbrnCsf7kFumqu/Xy6VejuNm7CNvHsIQ3XiJU5MUrQYULCWYZOLzN1Y
OSv55CUvV03eobPIHq84wctLq3WSPCQT48QZcj0HxG4D+8a03DHaXx7Q0tydWhLuffQxJxDeDCiT
9jB7uKb1o3N2nfZy2cxCcAtn6J8Bzc5yEl4okir7/BUzxvRg9c4hz9f0PJZHMpN1spWMdxz7iNig
VaiRWEqzXyMQceeL1e76NY3BJa8mk/xfK8IRF8aKVgZz1rQtHvP2aoSSZDhcnqslEzDZkNgB3TzT
nJ/PVZimTtvP4PdmvB+MVwmKWrleue3WbAjHTjX0FXcdNmx9r/tfewUGszXhy6VTh9qpA6E+goDg
+M/HMSRqDJUYtwHoxR9FGtx2GhJtWrRPYCA1Stu14Y9dOU6XbvEZTzDnxWgGF2MgI6+iHu0lbHYF
INv7iAO7THMXIt6NWexAYCLWfXm5lvbqqUlhubpCTfxCZq+WqXVP38dG7dOfXaHsUsfed1a6cqyu
jVBYOb2iM80zmdUxL/JNow9vXiHVV0lXf807+ZvszLpToXOf0g+2MrnLC/pncgXfR1k0HpKCyZ0s
BK3kgsQVlCzdFu2HtyH3vsm5cocIwEobw9K+JucIrTF5QG5K4RpGjkUdC2k+C/sbng3aELtTuKm8
X5eXcSlhRh8VEjrAUgCCi30fOkDGAXQ754dq3smxuRkTc4v876GUops0/tbY6ZUBDtHwx6NvtD8v
m1/0ojmRRQYVSgORDdjsuq6CCpngPf/ZxCmOE+5Vv+NKe0ulaGUhF6f0xJhw6GuGHHqwgpGUgVuv
MF/jKb5yaiRcpI9E1fzcf4clnAEGSLzIrBjWGAColu0bK7OIC61jO+QPUSNvq6Bx7Wm1NXZthPPf
T+6bjE+CJg+7QVQc1aTaREbrGqA64Mq6G8ZxQ7vco99BBxPJR69tXtLCfLBCZKikJjmUcesqq0yV
i0tsypAHzSh2qJjOvwk0bVL17bx9yFwnwd6BN13fQnXgrpHELW7UE0vC6HurggUjYPT68F3X3DQ5
JhRDlGjr+RnKHyuuu3iXnFgTTqR8hIFAm8cVwmAij1898qQKiqmXN8iaFeHwCfrYkIxk9iSDftQd
yE+XaGzFyOLhejKU+e8nbqM1Rhso47xEbfNVc5rboDW3nfcKGm6nm+EuDN4yenUvj2ypNj2rjfzH
MUQlhagLorKYrQ5GstfC8ArGyo3SZbvOao5Ez5RXoi2kGM9dp+0DqdjZ/pss+Y9JcHX5S1bmWNQz
b0rJ9ED7zWlodasHKtyY4aGQ1mR2loJBVB14GEAYCGOycKJbSV0YTsybx7eMfR+ZRwDrh4+M5I8J
9Xwh6XgOob7nhKs7/zqyAppJg1dvmlbMLB4zJyPRzs3kWpPbzchI9NG/quriTumelcymDcRc8cyl
YiM9cGgF60Aw6AISJg3Bx1rSAoeoEE46FN0m4zmBKk57tfSvw7RvvQejdzO9g/xhV68hTletC/MZ
EKrWesVAVXJLuf5kBteBvemLGzh+k/YHiGz2IzTsnUqbVb+7vJiLx9nJ0IVZrq2+bKv5jZyHMJRF
m8k8+GG79dPPmePqa/C8pQzl2UwLt6PvB0WQ8srbBNO90e0K2lyN7jCFFXHVsyY9J+p2iFaq4ouO
NHc4zhtCe4dtlJykl50cm4UXXGUVqpjUcDNbOrQM8fJsLl5DM6EXAH+dbKXgSN1opKOn8lo2AhR8
iVOlVj8kvDAm/SvX1sqRsjSwuT/dQV4HPh+xDDnmvm5Iek7Ar1m1W8XJP03pdBvVN0N3Uo3Pl8e2
VOKg5ikDrTDgR0JW4XxD+jkamLKBOTrV9EMdF7dNXeZbo/GHKwiRzENraj+bsKzdwW7zrTbA4V94
00tqFmuc8EuHKYc67QE6X/OOD1ZNG20gyko2UeJc62250UvrLll9ZS24K5Wv+dGLNAHypCIxYRP5
3f9wdl27kfPM8okESKQCdStpknO2d2+ETVbOWU9/ij74P8/QxBC7wGJvDEyLZLNJdldXEUZHJBGT
B1b+qMf7Cmy9C0RybFTnN50GSS5H4UNfVxU2kRoDPJZCokUsv2qMxEkVwmZa+Eb3mLAWHMGHalLR
Xans8L8fnccOGVKoSiKlvjh+Pzwu5dZZb1vz9bzXqKzwHXNkpU4n0OkzjMbKIX7K0LRlPJo6KuNP
5+189Qg+a3BPgFx11xGds0liKB30fDT54zTel/pto+Lt/7q5T00IsSu26tV1uYnZ+Rk5B6MNogpw
hvdVVQX4eoaj50Qn0Hr7UDIT4Sc9CEu0hWOF5/o+at0HnQ2KnLXUAhRmTOTZuD6KeBcz0jhMQiTk
h9bv01eT/nXI5WyekEMEPx4XQxFWfYjrpZs/ku/Oc0e3NKy8LLwt0RJ0ftVl3nVsR7i4krkEBm9C
6ssugijPvcgBoRKKQaZiPLL5QukJxR8kjsCaJsT1ocfFrbaRmWrdW1L9ySfinx+IhIkLTznMFKee
5klQ7t9H+6RFJ0S5lLgeDlbtdfOTDsXP2Ck4+YvXVteu+27a6X1Ph22W3utjt0eB42kgNNCNFmxa
FWJEo3oWSBzeAiKa85ajfAPqDeGbBqicoZUfV1Y7vwzX4bJNjB1trO0C319WVfVSZg5aInB95ADh
NsIUVBU4HiYHi9l2a/1tcUIQxRQrxEX9Ks+73EsXwwSvyQD9xhLK7pFnmqPjrbMzXUQQCdm4w5pz
HeSlgnT1wDijVjp2zyGSSHdWNZoqkTbZ96JOYkNk1gQ0QkTDhVCIRh4Z07PgPeGFmR5o63zBkupq
1vrfZTKofIS36Z7WZyik56BATEy4Igqup+uxQDp3jhi/KGotZBI6PZjocIXersBZl6BtXKRxCvTd
TjtAGVWrw3/8i3H4ggnOD85QKBhH506nDSuuNvPoBu2k7zXd3To6kLSWtdUGKHsnE648gNOSp7GO
FIkqyQa0sPsgVsYVPQFLOh16iVizFiHucFb0c4qZR8BhdX4HSkIJgFwfhQfQYKBJ9NRCPkZzQ8cQ
WdtwY8aHxricQZBUvp23IjmmTqwIW2ouYwP0i5jF0Tm0M1psm1uXbc7bkDwoKIxwqhzsI6S7hMnq
2jVZ2w7VodKatxmaDbwocg3f6Y1l17tZBiWGKQvyCkTcc9rPN0CaIXljTNZFVwz3Y78uii+S7RS4
rgVeQJ6wFmtkNAknEwBAUKOSd1QSvILdhLp2N7gTahVzoBi+zFPhouDxxIuOwGVOV5KOHcra/ElT
GyHEUoruygXR1yZuqubbmNjpFjeF2z5anRsQXl+nTHMgCpEpHPZjksX9ggWAzKmB/QqM1ulXhBaL
5zEEIcVc21OPFuGC6n5kF+aT5oIip8+GFiTvc1bGl8BwwemSNEOZ0kCT+cFx0vZpphmIqnrNMX+w
MaIB+GzXAUdbkV3ozVLGm2zFL3ldb3dPlZsYQR3WnO2s7JdNtNrFM7F7i/PYGE96b2rvTdk1OzfV
yIsVhs0+75ciSGNzvYoTs0AlJAxjLwIv2t0QtbMKqPT1mYm1x8UM13Xca2xRxiCb8fAmY5n7jKDf
izh3pfWrRxkhM1qwc9LtrAIxSlLOsAiCAH6Y8Lq8MP/paJvT4OC1Miwbl93TKCiH19J5iscfELxL
kIOxr02lfKNsf+MwQGUWFO2gyxS23pSTxYKMRO5PMchVDa7skt3arakAA8iCFVQoQeWBsfEXyqlz
TTn48pIZSOh8cEHldkjq7yl7s53t+a0k27cAu0DX2uYRRcxZTVVLB/T25L7Jpg2Z84PtZkHcmV5O
v0WzqTjfpHN3ZI2cDmodyZimLaz1KwjECdnkzl0zK2ZObgS0+AAjczyKsEAkzubIcaE9OBfTr2m2
5zvmjM9V2leKMrPcASGdgfIcqrNoLTodTgoITzvx13kVTsCc/uwWIGsuV9eLZlQGN8S5GNGZWqto
ovnSi3HHdCk2G7SM0MEpuAYzeye0C8yi3T+vw+NcX0QpyAe8THvW272heqtIsgLoBABMH5RL4PZF
Qf10mAME/Aqg6OAj/TP61mfq61kQJps+85z0jeZ+BKv2Dat3531TdiM4titc/VMCSsGJYZys63eJ
M++nRdUXJnN//kbCZKJu9SWX2vZTT3IQnfLW7Lo7NNN+aQqOG67sVXH7kLnlsSnB97MqAuoNN2Cf
RVCfiuw9s3JPL/J/2NDHZoSjMUqXZm1jmAnRVFzPd3P25haVHy6/Y7Bnnl8gWcgHlgiiPS5ivini
1Hm2vyunHjsNrRrug5u6nmvdt+HjAIFpW5XoJzJ/sBHsoXZEQWMmxnuj0campfzSAxxnb3hu/UhW
rNxGa+678AW94Jp5PUQ/lsov2J5m7119Ezs1Kjc7Nl7q5u9Wa7yifszXfWkHSani4JE50/H3Cf5q
Nx3NrAj3AVBGp7o3LtvWuafdzz5R3Dw+MNliBMCJB/YavFZxCgmBh7asM2ILM9GSGDCuXb6gmsHJ
Y70+u2/sJYgN6mV9uckrHL7595qCDsjPm18Wvcjml5KBcnT2dft+jhQRXnozPf40wc0HUlOUeTEJ
TXEJNipM/gapoTYNqPuUFls7DcZsX0GDLSqC8u9bsCj6LWEeeClwLYlviKZB0gOZKIgGg+scuVMv
NP1JJZknC7/HRvjJffSOz7raLdFgiAuA8a3vPavfOcWWxk+TtS/CW6ICSMguAsfmhOjbNIsVJQvM
2VbqM9sz6c2MZjlX9TqSeS+e+jqUAZD5RYX3dFjDolm2USHa0mxEx+GhXR9iENOZxo9cxbohiRs4
Lj9wxEC3Iad3agqNsWmRmDCVpI921KKdE3zE1W0ErkXqoyHsfJSSrNeJNWG9ppREuTbDGvRS1gac
j+jPT2LTs4lXmN/BswvIiyIwSmL9iUlhzVI0IpfWCJOkpRu9H4KputZVjiFZsBMjQrhZpzQNW36Z
iqbCa/ILFBwxrR6Y1sdGcaUi0hXDfkLPLFJ9KLKcrlhRpmZuLnwO88dkPkzJTV9SNOkFVrQxy6ck
Nf14/N2VvxP7Klz3Dm2DybQ9qm8ZqMiTQx9t2zAPjGGDzip/zgcwbW5xo8igjhffTu7fH4Kolnx+
rjA1iI9DSRL8fguMggvwktHunObnpLGN8/u8d0l4RbnSwqct4TbWMvTorPyWEjY/KyvotNcE6VC3
97L4oC+bNtnW9Mo1NqS668HOtJR+Qx5c6y0v4l2tOoJk4ffoayAifbpQUC4LJ13H17iYZhRWI4jA
+lame914ADG5F05vQzvvLOuuLIJp/oeKA8yjbc6meJmh7/3UPMiraTfzq2nY3M3uE1kBEaku5lhx
AEr316cZsZlXW0PN7RKYKbu3pJ2CqN6XTfkvm/jIiBAQLVOLZ8CaMJXa9w682EOysVVEwbLYxHFZ
vK/CAQOVsK+MYZ7yjJelY/tnHh7WHEKRh9YB2Wx2WVWv88t5Z5XNG/p6IfeHpBGgzMLy6L0OfG+0
YN8tG43tLfa4/sMRzFuH/2dCXJqaTJBrr2Giba7z6Ftjb7RSsbvlo4BqOfpbkWwSc02gj197qk04
Ptb9Yr7q6VWr6iaTmkDlxNaRJkSnqbAu8UiMdnUwinF+BAp6ya5QdT2/FrLKI3j4Pm0IQWqxoHUB
mRH4V/u2fjeRc+98zfpDku/DeJ/jWLSGQmFTPiy8c9AThRekmDZs6n4wKwCpfKs9RNF7guQR/XF+
WLKTAuWm/0wIp21o6KxAKh4sreFm0va4hFtBWt6s7oZ0ive3ajTCIrlLlMfmAFMuZNcjYz8l3wGP
Pj8c/hvCTRuL9DkcYZGyYZk6Q4eNJlm8JPdM52Vhhecal1RVIOIzc86UsDkNp2lDo4apqfplaBd5
917PeCjuzg9I9ppHvswgHB+NS7L4aFvTCUoo0H7yF9zugJmEZIvhhcN46TS2H5IWL7n6xmF0t1jh
dexE93Gj6DiVBb3jLxBcpAYKFmQM+ALKDuPyxx6fCEWJ+gIkPBXbJrpqxDxQCxOLzjKLgJQM7dxg
Lz09lEZ3jefJsJAnbCGjEnt58uxUmzy8mM3Vm91XihRyj7fj358f6D8Aah49+FD4ERtrs7ZvQtCI
foQpxoKi343z5vxiSmYSjTVcRwqKVi5IFE5HVhdOPTcJBMnsJvF7trX1XUw9VN88Kwlw0UpVKS+J
jx4b/IhpR28fm0Bfop5DLJ2ZenlaA0t8WIerlCpqUZKtfWJHOHtHHc3oZuEiWQLxdeYggT173T8c
8CdGhKeqUw9WWeJa6sdohnJDn7qvk4qTWRI/QB+ANCSHl8AT+N+PJiyztbWgmZ37KIteddUA9ar0
sp+STcX7N8dUMW+S6HtiTghXYMSBPocOn8vJ76xJvIQYXq5toHvOMJeqrlCVNcH9WmvATaCENWIH
bfoDSEzPbPdzFljkPhvez/v6V5cwUbxD4MHVEo8QWxiarod2OTjQpHC6BtkLiBiOXlltzxv56t8w
gjo4RKhREwf3w+lyWWuBCugcof6KarQ5BI2W4HX64GiH83a+blzYoYCRodiL65L4nkrXqNLrBHYM
4z0Dcy3EzJpXAsm/EexNzuTHluLG/NUPTw0KS5XrU2VADhgDCzdtuR/di67/BjErpUyb5FpzbAlM
4adTCLxIPZU9LK2mTXFrDsNk6/RhdG3QNN0mLuQw6qKtfpuxHT3EBot39uBmT+fnVzpc6Ohy6Qpk
NMQiTdi6LS30BHDP5roD5Dgn98z5NltB0yp2nHQljyxxjzra4IWV6m3pwFI21YGLG1xjQ+ZrBspz
H0+vo3lv9oprj9RHjywKIYWZIbrAKSyChLuaNitxAGi9Det/qLJiJVFfQ20TrzkcnKdDM+e4hJ4u
DOmOn9i+ZXTeOIKdTffa4T00H/TkaXZvgIv/l7X7z6wpOBCUddPILvn4DHAPgeFLu7PdTelu9EmR
1pCGlM8BioAHI2pBO1DBkmZurPx6Wu+M5e38YOTb4ciGcMgYmlY7QxwDSs15KapNgYpQv3aQmkuA
i30eU09bDqOKJ0A1MuHKoyeOPi4GRjaSNdAALJzn7+Gq4rhTWeEJ+yPfD92ysGruIAm9jNPHAXrm
mUoXVOrtCJMgaWLIS5qCt9dtUYWrCxuN5ZVr6jFATkEOECPbdX6lpCHjyJBwvmRu2YcG38gzcuqm
9itqrl26WVuvUalGSUKGbYBqhTrEALBVBF1p4ZC7qxPhYjhtrPJ2TILeeRyrG+AWsipwir/3cqj3
AEJroWKAgoEwg2lMo5FlCZIl6ZVj3OXWW/H3txyUY45MCHOXgHMznRYk/bPyrid37fjcVP663JLh
748x1H0QkHBCo2wtNnc2A+oezgiYCQvvcv0xbXzGfBPHTLrsz7uDbOOemBKmDcAz5tQ2po3l7732
ZkME26/qxeuGa6N5MdLrKBwULwaJr5+YFKYx10wTRL0YHTLUk/G26rvWvSpV5WP+K6fPIV47+5xD
IayPS9atC8PAXOP3Mv6A7l3oPjTxQ57sQ6LwPemIQH3GUzW8LCPGoWHqYmj+oXSM3OMILEbSQcTw
ig6K1ZJEIggNfNoRIlE2jYRmPexE6y2xgrB+GlWYK/4T4rRh0rCHUAcB+Ejwh7JncUVCANJDAiim
/k5VmTO5ARCbgbcN+TnxMUcZ3sXOiuZeqIVBUp48rlalaPWXmkDCjBe7AWkU4YVZbFgTBs336e+q
frDRC3N+18jWm2fk/mdAOO3i3iDzWhZIMBX3OiI1yW6d/CFWaQHLlvvYjOBWbdqMOLcxjrg7rOWL
03hpqPAoyXHAFab+G4ngUXHURfGcYSSsetGSby6E1CG1mS2Zl6u4CKWrAjluxiiX/hAVuVlmTkan
o2RvJVdmX/td0SiWRWVBGEyGq1tVcaAK1I0oMiC1SitOuiBHQ+B/P7oJtH2NsoAL8JcWPyfmE11A
5DspVkRqA5ge3sKFOoKYuIrCtWyyGcCrar7VtIBVV7R4P+++spMZpeP/THD3PhpG3kZdZtYwUS83
kFQd3MAEbLK+bjRIJTeQZFV1E8liMWHA2qIciry4mJAFpg1aQRQ1hnjZNnYXEGgO50ug2VeIzw2Y
bs+PT+rUR+aE8fUQ7wDDDMyx9moy9onz4tBgafe1CkssX6vPcQnBchoZ6IdWGBrm73a6a5CZNRXP
IOlYUOvnjVgcfCIcY6xxC7SKoMZH66epfk7igxkB8fqYpv9w5yCfhkRxwmaYhqJoEPj1ZT8WT7jD
57U/AoFpK1oQpJN2ZEhIPkSEAb8LaKtvx69aXnnowoQeoMIFpBHaRfofHCzoPRE9TgdUPgW7A1yc
eiaqWi0L9AEduorbtDTiHJkRPM3o09SII5gh+r2mvTVacN6TpdczAJ+xxJz9HFfb061apXZahhx7
1KxQhdPiS5ZmAU3I3oinS326mcsS8DRSNl7pdoqigGwOKS4BnIGU/xNs92BmpmsJ15vZbZXlnpXu
Jw2418P5Mcr8AUAnfgYhO8hEwsG4H+naMfhDZexI+GdcbhdHlQOVYBiRhvk0IvILgnd/APMGjAy1
D4xaQNh16HwznZ1r+QYAE+VD6u46lcKizD2OrYquvlCgIrjVrrxMoMNZ/31TGoblwC3g6SCUE3MX
LRnXeq3hHv2s2YNvOmm3o2jcbPzGyWxQgw66Wyh8UrpenzbFxAUAEl3GuM2m+lE4EKn+Ngzb8y4h
d/sjG8LENdMICq8VNgz7EHeGN7UWwFV3eX+3ImPZhUGlbXSyOW9VdixSvL5B/IcuDCCFT/faTFcD
9QcYDXsor3iACqcj6Pm0BvoyPdtZEyFB3dXJtdaHSCwuhbE7/wGyWM/VGzilD54SIrY8zzVGhxwf
YOJikdNNg00Xurmn5S+kVFwzpJubV4qQZkaqWeerfHQH0As6jK474HXeJsGalhsIXjcexIlxa7JU
naBSlzkyJoTJtSrzcG5Q89Pru8UM+uk5YwqXkc6dy3UHARjmfGKn49Gi2MnLfILHNCWoOTTPYT/w
zATIFR17saU4XqSu8mlNVLxq7KYHyAwDWhLzMWbf1vYtctf7otQv9ZLh5ERriqlC8UqjyZFRcjrE
PGo0EhkYYgFkKL9Cjf+Qk0SXHJqi0dqCu5qYKSyKGrrpMYZlpu901bx18qjlueWzpWqjkC/XpyVh
LCjfzHHHPWLQ0avTebbr0+R+HFHf+/YPmwoN7Ch0WDhExfcmpNwi2tsz8gCABzn9DZTuR/YEBPkY
qhRiZW7+gR9HKd3gjGynC2RnbElogQVawQiQ1dOmGfA2JC/nByTbuaD/QT8jHrc8vXZqpdKtEvSa
C95Rzo+Uvs/AATfhbWcrHtGyFUKbGhoM0OgEUkAhBA/dMEVtjHmLtKshOujkJp8uSXU/2Io6ufRs
PrYk+IIOIMUQ93yFjHq3tu5l2gNXRksKYqV6CIwRbRpVsyNo2Zi77ndtvf3DhGKEQNkgK/FF0nlo
2br2Lp9QsNq6mhlEzaZH5Ijez9uRuseRHf5KOgq5TNNy1JN1zCi7TK1LM91qneJslsUl89MEFYoK
2WxDBDnBUObxdXGR1J33KWh6I/q+oD5FlhtdpZUq9UZAbCzgh2yU+QQ3cdhCJiPEoArUuszFt433
GLT7JFHctKXuiMQuAzATKAdLsFMsyUBSC06SrXsUYevkSZs2XX1rqfKG0gHxRyrGg0uVGAPzIeqq
KCXwxlw72O07c8dfbg52vbZR7DCVJcHv2zxMlrCFpYncgwXOLF4pFwyLss15v/vAu4k5PWj+/jck
4WKDlzAQr6GBITXseh0rj9qtP5bpc92ZD202XCV6Df7SJ1K/lEl8h/43T0vWzcS+mXifLXW7We3E
d5r0YI4qNiHVJPBD72hTDLnV2GaDbwO7beduavNaj4NWezg/BbIEBNLBkOrDzQ4ngeA9UeNOxBiB
jWHz93x4H0d/TQ96c7HU/vT7vCnZKQ2CONDA42plMbHsYS6pMTFQ4PnZfFsZt6BA8M4bkM7YkQFh
xjKq1UvWwEBj50FKr5Y+yBu6Hf8l+3g8EOE0c0g1FvYAO1byPSlWzzLujezn+bFId/XRWPhYj1Yf
rf+AaXIby1B4afY215GfGTF64x+YqoQtnTc0M5pQ1WAQwRbOzSka8QJcYKutQWP5NneeDpkSVUlS
6mlHVoQgD/GMCUlvROAYW8dON33oAYU16Hcs3Jrs6fz0ScP9kTH+96Pp06N8ogYHuSX6dQjQdwfc
+dY1nuLI79p9kyiuUooZFB/RpaMBFL18HJRvQ7Wba8CwniIVp7f0mMR9jYP2PmhxTgdl1BVEoKoV
j2aN7VYDFMR2fx32zuH83En36ZEZISRYCeoQITjF/Bjq1wlEuMnreQPSRyxo5P8biBDfG0qLzASV
g7+Sd3PQvabdT+6LaT6Q5jUGYgnqU6xSxXrpjjoyKsT6OR6haZ/BqFUjtiMvhPthkCWxh8txQJ3f
UKLaxuXDYOOG6n6bk9jXhtdKL59GtEo3aQXS5+n5/ERI3ebok4SApQ16ZNURPmlMJzzLHusaPREP
rbY7b0a2oOiYA/6Msx+AWeLUb4q6L8aqt5ELIUECZqNiXRV3ENlAjixYwoK6UWa3RcJgYXyd9WB2
7g3nDYRq58ehsiKsYJhismjjICbmf2YQRESZ18/fe/f9vBnZNkNtzOJNHWjuFRPL9lR16dxgMAXy
GyjFWOZ2hQTBeSN8zsWbx5ERManMSK3HpIWRBi07RfToNoGb3oMIqksvuyoN6lHFWSyLv8cWhW2t
k8hF7zos2g04i/2BYAcQbymvpt9ZqSppKebQERyCucNIlgnGtOopG4J5fKaKkGtIvcHl8C4UNIDj
FLyh7zWzXQbkhKy2e3LQfLmfF7J1mvUN7J2Zl01s2s1duwQJGL4umJ2/TVWD9F+6cZNf4Ja4sopp
S+e1VwDCZHGGa0hAS4JrZTjCPLtkMGOdA+DZqCHXkYARIkSi6kdqe71K1lQ2zce2hGlugSLUCsj2
+XUzeaj5+2v7y1ShpGQTfWxEmGgc2xFbOMy+XABLiIygysebQgOP8D+VwJGNJiiE4XEN8oPTSIWr
CYu7aMbBYAQWmIrj8sf5bSddnCMDfKzH94KURa5TwEBkoBEQsHM6JF44vlTmxihVwoqyuAuCEgfq
B+B4oyLN28DMRU9mkxcsv9fTr2banh+MbPWPf18YTBMPphOFFK+XNfYj2gWx89TPqp4R2ZQdW+F/
P5qyEkWYsED7n1+lh9HahTpaQkc/Z3gNPf7DeEDngaYDnFVI259ayqeigiwzzqnFTP2m29Ih3BJH
ETeki/Jp5ONucjwcKxxJp8NIiIYx5uziUdWXKdsvDjCnlMCVgf8XhlFCSamaUxxTtNmvUIcrvXJ+
SP8FLXJkhQkJjdKxkPEkGAeJtoXxPoPa5fxqSHh18cjhEnQM70OgyoVxDIOF+LLAgo3KQmke8A61
h9tk3oEGi4WHun3FDs36XR1BLwf7FS+h818gn8j/PuALsa+mpS0g1Dz9Ffst80L7uere5vFw3ox0
G32OU6RAifQEAnIdxmkYscdwNuSPrurqIt1ELqdh51yeEGA5de1woR2oT/CYL8HN0z5ayUEvD1W3
SVUoJdkpD/b1/wyJMYFUS5TGSJ0g40Sm62l6XrS92b+1xd5UVUqkW+nIlvCim6q0zBcHtlKUYlaQ
TNSJ4ixVjEZcmorMZrcwTBspYq/LUL64YsNV0wdm9j23FXV+mTGILkJuBblOZIWEc26NXDMfeGSY
s2qbEOIPjnUY1nbfGS4oHWavb2tFIVm6x7jaKgAgvCVLbGWkfZgkYY57UpX4IdU9lEcoTUAJdRs2
B4t5SfgHFzcvbW4ycuVkQa9Sy5C+xY6/gC/yUTzUWDsayYgviKobMgdrFFjTts6v4+i6bXZR+hDi
bXJ+w8ltItHAs+fQChAzQUCh9H0CjRa/QDPCZKJsc5fUd1p7GdsdmAjRzV5lHrq2FWb5Aop37g/2
UIAfOE2EcJLljJVFacOsW1Ltd52tHXLAkEUYZq04lB0HkwJ/t2vQVOU7aUpxOybT+q6zVceXodA5
DtO/AGXAuId0GEho0NYiBNkGOYrSXXkHl155Zf/WsPdayfIo26hHRsQzb0be25xcNDqxboBwqo4q
lmJuZfGNF0TAzY8+J1d8YloZCHaiPinwNIu9Kvo1gGklc3+X9Z2y4UIWro9MibkWw1zYlCRR4c9R
HkAb5SqZ44DMkyIHrTIjXOOHdK2ylsBM2D509DVvKTajikBHdsIdj0W4v5NyXfoijAvf1DYsvrDZ
LS5V6aRYHOnyfy6OCFfJl9UZNR1DwWvEcxrqOSqwpGocQhAJdaPQSwMWrOx+KpD/gg3T9eJ/KcO6
oPwDOTWPmOKVJGN61dQtWJO1qH1JHfeuNTRI8s6X6GjddaTfn48Y0on7NCdeQLIiSa01hFeP1rCb
jfl+xYlw3oTUzThTAldjA4uS4Ga2EVpjVMBEV/+iaEHN4s0UfftrGw6XNYTuAXCTeI+chvjB7iKr
0eoCOkhLaHpLqOt3aLRIncAsyzzZnLcmaTAGtsziutpI8HFGz1NzUP0N6WiCRsssUi/VEEutqxCF
+cFB6dev18xjQ7w38jva9luImChOF8kxfmJe2FP6SFJIN7eYUXOrIbUMKrYxcAHapfqtrikuKLKj
7MQaP3OOjs8O/UNZlsAapQ89nmJrvwEvp+fELwPFOYPkxFXY/8OGPjEqbDdrAcVuTzDDcX1bRxPu
XqqrN+GzJJyVJya43x6NK6KsKrQc49K0+9DadmxD4ygw9WsrfMu0TVJqXvubFto2jTdx8hqnA4dE
4sXrO8DDJZeT/UuPvi3NExtDlYPxp82Xb7MtqMB8aIWK5AxofSsaUCMWgKy9FCAYGH9Y63aq2a5o
n8w1gPMBHKzqhpNsVLw1gDcEYzsSg2JaR1/MsDG4Sm04eyl9savrtN+e3zmSQ/SjKR9QYKQ/HLFP
Pdd0OlMHpA8doTtn/kXy7RJ1/lzuZpU4oyRgn5gSPKgBnInZFUzFRpBrQIDu3XK3qMglJfHzxIrg
ROhN792mgxWW7WZy24Eb/vyMSRcFd/X/zRgf5pGXQuatInUCAykBQ/ZzMm7jRAEzloEwgCFExRtg
U/K17yOOW1Axj+g1cBJ9g+YZ6K5tiuxnFgaJcUXRE5Rt8wTCaLoqRSyLLSeWhbit0RxcapR3OTT3
UHCtikBPfyKRACbopA7ALat8CktNojcNTI+oBiMRI1yRDTcNczoiqdoPXg7SWXTtDiCW7L1+Gby0
GNCsiFtE8NerCNTzp1FxnDpLl4zjJsv1rrLvdOPdnn+dN/HRZy/EjGMbYr69G3trMnTYoPX0ZA3N
RRouXgqAfYeWrqynQU/f2/zNNh5xD2/sq2KONwZDeZd5eoauQys+JKO9XQpIAtjPJNShc/YrQest
cCveaJV382TdpugWP//dkn168tniWZqMsWF1+OwRr0BSbSfjxU0CrVSEVMmZibMa8EUddxBk1IWN
GplxWHcL4LiLvZoviesW3yN4B5jZTBpfYlfg8tCXdlthMmIwEp8f5NcwAV580M/iggJm+C+kUVPe
FGgYTwAMyB8r/bLMFaP7GiX+n3efm7DQiiaMrhjrpA1T/H6HWovbRH6qZ1tXfzs/CgmYBGaAlUKq
DKl22DoNRryiaUEAD9wLyUMLis9sq9PdDJWyKAIw99Zag2b0HPeq95sny/R634dWbb1dVRFLNlzo
1AIzDk0sME8IPtPHtZEuBMNtqj9VZl/1i7ZbBqIAp3207p3uKFATQ2MaTAxAH6EEczrcVdcHrdYR
nSbbXmNPA7rk3YgL+3KpyJh5et4DUtg3K1RyKtpBVSVHC+BaGC0NjCSp7gw8q29RqO8StFW6nR3Q
KSSbqWvHGerpQ1F6GqQhK69vsvgpdIbuaVorzCDVM7YnYao6rPjyfBkPQG7gY0AuxhFDXzMUuW2m
LUpWZoTnSw3509zNwamuMeY1pLha2hz3uRydZqn2D9gVzCbuymBTBcQUmLHT2dSM2YVABHZglb9H
9mWY7Mbw1Sp2531U6hpHVgTXgMLFmFq8w4R1D1kWGC1ILozn8za+3mIAqEIXm2lDRZRDtk9HMnSA
2td05GDc+o4M1nXs0p0drjg+Ko9poeLwkAUP3l4KRWsoMzOxDNg1VIuMAUNqgWl2W+KR+Mf5AUkt
IFWFGwAXgvgSPsIKTKMxP54ce+uaITgkFI0/0ik7siBcY5YGldI6g4W5uh9BID096umlm3WeqxIS
/hrosTguJzYBL7aB/4TFCUeoSRIAcdP1BhBIvdmH8aacPItB0nFzft4kXIQnxr5gwdswaksOy26b
oCDX07Irmg3LNka0t83tTIOquy2SoAr3jKrUc2WefjRQl79vjm6G0B4BVIAPVG+uWqTC3X2kUnWT
BYxjE8LTr47dMDRWmBjyYJgPYA1AiIcOQOpuNeZ3KkFwSa6YTydOFjzmsXriu3ous8wsAc7xo3rb
9Xf6+kbSPetulxi6D38YPeTm91qbUNKH1Jv+o7MUGTHZPkB0whEK+B5uh3zKj6Y0bOwoHSjGW4Dm
BL073kgU4UlqweHwJmhEA3IsWNDXus6IzZFHtPOM4lpPVJxckuQEQgVmEYRcnD9d3ABto+kNdFxw
almoJ10Wy4Ph7rXsOuo3lR1EbuY1HRAS+KdI9ct23pFhcTNkzhj14wjDQKW72s6gP9P+xlieu/rC
+HuA4skgRY26dMHer/kg66jadsuPeiUXWpwE5/e3akTiFmvK3F44ajsGgZq93ublJe6/of1T7/fA
jymsyTb08fwJu20A3qPLdD4mFO2d711/kU7fzg9IFobRKqbzPmwHEDshONa1BTrdHp0/LDRR62yT
P8lING+qoJYSz9G6AV2MinVENonIk3HGdmD6GBNcftZimrgcwVFkj30P3nJf058rw1vci0lFiiSZ
QoPztH+0fqLhWBgfqBKNSrNhq3eRFSOm/VT39rrNHVAbnp9JSWg0wC+A1DYXE0QL82moiHTI8k7g
M/AT6F0aS3ITVXdATN9oRn1R05tYp1tm4Tp43qqEihcXp0+zX0oD84ArgoX4kczuHq1VEF9xgih5
oQvZa5p90dVPbRRfjnEX4BwHkYPp+gu0LtIVclLOs5nGe3MwfdNQvD6pZJXxYXAr9PjjBiEiQdoo
HSunhPOyCp0N2hBlF7FV6cTP3SR9wWty/cbc3D0kdJj2qblkQTv00+TVpIfMa7+GXrNm8WvZ1vpd
GZI0DPSpt/J92GUDGJSnub8oZzpDW3SxaeCQuP49pGM0BUQr5t852Jv/xCGYiDtzXmZvSmzy0xlb
61BOS3a5RGyYfZzV68PgtgacQs++hd3/kXaeO3Ijy7Z+IgL05i/LtndSq6U/hKQZ0XvPpz9f6t4z
qmITRbTO3nswGxCgqExGRkZGrFirDK8Yc6n3ANTq9FbKWuculrt8pen6/oHLJ2MoDZwETyaE0c49
JYkaRQ8KevxKfc1TQdL+GfO7xFubqvqtDTDL7pkUp78mhp0YpJ5lvjx8u6YMdHp/XZXJmyAIujv2
tP8VtlJ9lPUWsgozLoYfdqa399nQ08KQu7jYxUNcX/fWUD0ncU5lt4HQ73MV6vFjmUjtj8KRppUt
WXIWeIEMkPKCE3juLH4r68iG0Ie2Rik8SOak7szSuSqKqrrSNKpAo2177pjr3ccveMSxwKOK+xFZ
3tm34PFKNf93f7R+gqbQtczd5QO69LFPDcxieKP7jS3h6BsITiib5FLheqG8iT5eUGLwl2RdkC7y
f+aBXCq7sg1FO8o2y13bxveZ1rptV61c6QvpCgQNRDlei4LAYfbSydKujPq4pw5t99tQ4tAOm8sb
tnAj8SCEIpCJNh2pqdnt0AfI4XUVC1HHTQWFOJrWrQoRZudWirZia+Hj0IU2TKA+QtFm3iXsZL1I
Oo9OdJC7XfatGh6afBetiWYt7BlWqEywaUKhZ+ZjseGEqj0KK9lX076L1hoXa3//7CkVjN3UJaI7
bA+ZK0s7f8hW9mnNwuyrR3JkNqnKCjI1vjK76JgXx8tffflL/NkjESBOEu2yCJJyGllDmfl7R4MQ
ZvhiUoL9+EAX4i02ZTchZiy4bs7tGJ1SBF2KnVR5mozB9e3vjXbvRMHKji3kHWd2xI6erAdFqXoE
wpUyMPk4dnd1/0Vqv17esoUq/flaZiclNj21HjpsTP5z5AEMT3eZFbl+f2ymO7V6CrMr2fk+/kVE
O1vazN1MaESl0BburCPrWW/aUt4U+Y229qnWtnDudEE+Nk7L8jz7xSgeKn9wtXh7eQ/XbMzcbswn
L1UbbFT+82Qf834DknktRVs8PRQLmVbkEQvXzrkvtLYa+nrNhpUOGHRj60A6NrqismbJn0e4BcLX
KnmpPdQ2Qei2ySemTi8vc6HHgauInBsVeAo6c06yvC6BTOe4fVvuNeupS/dAF/ZDufFSx5WB/snD
bfJxYlkDSU2RfXPgKLXPMmLLjKexUixS0/TIKB98K3a9rbrd5bUtpA6nVuaAhcpJbSi4sGJUb1mx
1ac7uyvcuCaC7L307bKxJX8RyHsxNiYobGc+ORVKnNsyqKKk2lYV0kMWtdLnv7ABCYPCzaSLV/u5
u/RkOU7p4C5h9ivzbxuIVtZu8cVlaFx4CFeSnc/hunlfRX044A4CrhAI9B/l+jWy/yW3d/4YmaN1
BzuwomnCSFN88uidh39T8DJOLcx3ihRljFJOr1QWLp1Js7321viel9IRoAUAm2GQF62a86+RjhZn
ugd+0yi38rBtu6+dtdfiq7F//YvPrvMIpxQEpOy3EtjJjQGlbQonLZ/dlI+Tt/WrK0/9fNnE0o0h
uERAXf7W/J6fyDZvOrmZQN4oyddCuub9s8273Wg+e9bedg6x+suS97m1UupduNuxikoVu6igAT/b
QiNoPZOWLoEcQQkVtezQO5Y8xPI1YIr43rMHD4aYCId3jeba/OQoSZvUahoDJjDbXa6VrmczzcYM
zAD8S9kBywBRK4Ga6tHVnuIfl3d3wd/PrM/SvC6OZckGpwGudXAz+14pV9a3uI8M2DDLQdvEnDe5
EqurG6rmLI+AHUu/huFZCu6CtctiIThg4I+Z2TqaQGvCysGM5t8istgFR8Pb/8VWnZiYZWGTKtml
H6fgGaHq7WswwP6nyxbWFiE+1slpkip4jjWxV5Qg3Nz5FXSolhUr/cClaj+DOzy4eHJRJp4/W2Gq
iiXIxcBioLtWhDztAsYGNDfL7nlwYw/2bXiPi/zz0H721lBfCxWnM+vCX07WiHJuF0kyDpd20aF2
rBe5K28EXZavmSCymAcfUhyxPlze2oWIeGZ2dgeGSeTzmGLRk/Zce7eJcTcoX7Xqm7Y2Yfn+G/IO
tOBQ0REGp7c2yx/SuoceULYimqly4MZteZ+akpvIwUp8er+PorkApR5iBbwB370JmrZsstGM6d7V
rt7eFcNLX46bXruS0a9A1PfjOFuBNMEWysGcgnlBfihSMykKK97QSZaUz3HwLNVfL3+kpb07MTEv
vRutmTlejokCGGelv2mtua3H7WUj7yPeb8QMl5XNNYzkx7kDjtB89/2AJHVp9Tszqrf9Wg7xPuRh
wWakkLczfc55qSzVJTOTQ+TLrc4tpCtD3XUaNFzd6+WFLJhBfl2UTRgLEM59vhC8LO2cFvhA2n42
nBttQAL+U6usvAmXrIB5h9uORhb1DfHNTs6rIY2mEns+VhKP4ZHSe07k9r6fpPpKkT3peHlN74+p
zYvjjzXxa06sxZYRTZKGJnsWlrGrF9+HLPmk+l/tST2Oza/LxhbcDRZXiBQ4R7Bua7OAHkVF4JUl
7uzkPjQK3wegU2bxctnIgrvZ4hMxZAqqF7qo8xUBRm5yS7CUDeAuDJdUxnriprT/uWxmIRz85tm2
hcg2sMRZ2BkDJ1VKgQezvH08vQXwAEUho1/bXNkD/qVQtDY0SROOn36eudh4ORUvgCUqdOWzTDaY
pNQJfLhktcKuJ1fWvZFBEdl7BBzJ17MCntxuwBT/xrK7duv0Qe+Wik1WzRuZuQOJ6ky90Xuph256
qvurvpf019SrSUVCuSuOUaHF07bTiKZyajbBoe0TtAY6IuttXfXtLRXk6r5URr+9KaxQfzQnk/M2
jdNebcbgxlRT+Zs65vbNENr1VYt7hQyPpQRmfdIVmodxLEEx5Dvmr1TOh/2k2+OPUBqNp7z20peA
TtaXIrbbG92Jh72BjafCBvVRZJkabNPB6a71xDTfujKA3SkeA8Ud2r4Zt4ovZfd5CKB5kpPa34yV
3H0XjJ71HgK0/Ko1J8J21VvpY59VzXRDl7X3Hh2QpQ+MutjdpocqsXGHLMivLCMYX4u2CvZW2MEE
mivwA1DQNA9BqKEV4NnQnW/9dmQAaFID6SFRM/ktLifvKW/qkP6JZZRXaSdFWwTfUM7p9KzeULcK
spusiPNrPqPm7zQnHv9VSzVPYU2L00/QFRW8syEM32d1Hf6qmzJR95JVZbyJLauNeZf77Zuq983X
fPLRlOkCO/qBWIO2q/xWR1ojS7RbPagpvzWmJ7mXXf79G5qamCyY8ixgEgA+zk9WyEUVSCVcyWo6
bXS4H1SpOUyRfAihZva69N9IWmtcLR1mShJC69qBkG1eFDE839KzlFOmxXsT8FE7fBxix6JOLMyC
epElVt4ItlQf6VgpGd0+u7q8bWtrENt6EmKbUWn18XekwL/q8H5Qny4bWEgwoSjSuC3Qu6JFMY9F
DXjVPGtGihu5Kn2zOsv6mgV+X21KO6M86kCAuU89x+cUpmY3uU3gheq2idX0n8rXIr5fWN8UYd+V
28u/bGnpkI2Sn0FvR6l+FvAT3xt6XwcY0befJaVzzWCl0bBwWbLyPwbEDzjZW7tq4lz9TWzUq6+x
Co0jCAxjLK4zdcXS2lJmzm+EdhpZQlqxop0B+qJY1Yxauh0t3qQ8vKHwpgtwvpbQCYnPAptApNqq
1qsDx2FgrHyRRSM0FsknsUW/+9yIbiVh0aOvvpHsp67eJ+3W0FZMLH0TeFj/MzF7GTpAVk0voktX
D99iw9xGLZDsrKeDucZuubaYmXvJeZsXvcRi6vGoVNc1GfkaCmEhP7Kp6JAhgXsA4TPbr7Ab1Y64
J1AI2R7WwX16MF8CiJV17+NUrtAhnJia7duQy2k8SpQovSI8InaaJf7eaLaNfBcEH8/6zkzNNm5Q
LL+LPUZb88HbNma4hWE1yV91GSZ3ydxcDgJL1wYsmpAaI1QDmn1mrPTzrq0dtrAvNmEdukWARt4R
GSrXQC85WnOKRfc7MTcLCbUS62MmYW5MPTfstqP8y+vcLnm9vKol3yPPpMCi6ur7TiosZ62RGEBG
AsQPACTYgDaUaY2bacXKXDN2zHzZDEeS2Qi2KTt4NPVnc405eWnDTlYyH7RLp2oq49/Sp4VhHnot
rij7K3cTlHg0i7zo5fLGrZmbuXk4Im9eJ2ycpv1MrJ/M2W0KJoeC6MtlOwvdDJj7yBno2dMfBsJ/
HuoqjlPltYzId9y7qbFxjOdWfVFGKh/hNsj3zbjeOFzydQHZAOeOgh1MqOc2nQCOdT8HTKHlmZjo
027ytn1p+yLdKdV9Rw9HclZAEUsRyoGFnyXKjkWT+twk+WOvWT1cA1KvtztJezTi1oOtIZOvCrt8
g4djrVW1aPE3FwC8YELQ+tyi2TZ6XcaE3XxMLNptCmrDcR8q39TYk4JNqZdeckiHNl0ppC1cwYCm
NNOyKYbAOTx7cvGJs9jsaatkgXGVt3eWVx4u+8zCcft/JIwmyCw6UrOVSQk66HpL5VuO43RnTPBK
mlU9gMWw/v0LS7yDmUVwxCjobC1T4ZgUgolSUU5BRH1qrUOhlrvLRpY2jMlzwRnDTMq7kroy2UEV
V4LYzRzdgTEsbU15ZMEVnFMLM+ezJqRgZG0kK6InHz1G8l7Rjml6m49/kacLZC/9UaARkFqJT3eS
6cXZkI32KDCVCkOkrbMpgp+Xd2shMNF/pBUFaB140RxFHPeRVWiFBkGIcq3215m+G+1fubH2jF8Y
uBLtVbA3sMZb/Hf26Y0kbcdQpBRNFOZ7p/W7Y9Y51eRamWH6W8sJ7LtQToN73wnafFvlaXnf90ny
Ek5aeJ2kapofPMa7I7csW32nml7yIkrlt2o0QNyroswOityAgrPu+9pzo5zpq50ZhqNK4SA0XhIH
+pgNTRDzKqrrsuLZo0jZShYoVnFeq2B94KHhSKbobc97yd4Y+15Fg4CXmyHvxj7zNnpdS1d9IwyW
zbhT1V4/GGPbH6qutDeXP+b7k4x5ZlZgNqZJ+k5GFKXQPowL2orQlZT7xor9N3sEMJJ51cdF1zEl
0JyAdwCgz8Ph4ERKlEX0F5O2G11LycKroDBtl3GdNX6QpVXx5QTbl6OpvIjPDwHlGSnvE0Ztg7Go
b3LbLJ7UqLF/2IVGCefyDr4/DmJKiqBq2MBvIcg/t0Vu45h1xwRpUTyUGq0kdI278aAX0sqnWjRk
geZC78/U1DnRh6+apZXFHW1mwI1jqPBeDe9R49nVevl8eU3vAyJr+mNqPkvkFXouTw2mRhOOvzp7
GNvi62UTi58I7hYambbmvAvspZ5y5gpM9J2/TT3tMUaDL4jHlZtq4c3PUoBk0+cDN8uqzj9PGzpU
8ZKR/kq/b6fnMLmRoldfvTIY8Q6RzixvJjTSo/siAY756fIal7YRFgOhrM3VQpH13LYsSVYXxgYN
YqSa0zbbpOH+soWlXbQF8JsUCrDiu7pPa+SeSezdhMUrWm+T+vQ3Z0lEeRtiI0FGOO/njH6cV1PF
+GYfH+UU4YLpGJJFXV7Hwk6RBtLA4SvpXCna+U7ZRl6Gha1A/zEqmzbeMT+yYmHh9ICRp1ogEAYy
/zu3kJaMDQZekG2y7M4L7sPyznJ+9erKg3FhHWLCC5EAJgCZ4ZwFA0QysybO4mzTI/Cov5lrqjcL
35vAicA0tztNj3kMzeq2GZnhyTYFzLp9vFWzB61dUVxcuJFMwAV8ClGNwnfPd0pNPN2kxJVtSuWg
pJ96+5BbX3TzSjaePQPFFIZ6L3/8xUWB0hACAYDcVfFYOElZlBikut9jsItuDeM1sL7GDJT932zM
FjXGst/mNjam7MFrHyhZR+HLZROL3/7PMuYCAdUw1UC7MaFP415RkuPIlMDHTTASwQnhH2a5ZgHF
6vWshEUi20gMr4amRY0+/otVnJqYxcs6tALKO5hIpsp1GHfuVl4n759+pNiUAvAxh7RuHrJMo4O6
q6yyjZmHrp59it5orFLi2Jp0aoYflzdsyZdJViEJExAw1MTOXQuXc5K2ajIEsB7GDvlkpqllemom
/IOH0TMP8pps2ZIzs0CkhpgRgKJ+FsnaKMidIu+IM2bIeq7T6Hu7RsS7FMtObQhPPDkwlVZJvMqw
IWVu+Kurv8j+NgpWHGFh6yyqn0L/nGoU/fxzI0GvekMl9Vxaxo1kRm4avJjMQQaOq5g3aEaV00rc
EZ41y4SBdJIJwM1Ei1qdHdG+VhGYHEe+lfMySTc6+gHmRmsAXYxrZGMLH4l5DZ7Ijs518E6Mx9a7
jFxczjZVO0IhzutS/1QOa02Zd1YEaYDJrKzgUuTqnB0lWWYqhxwN6GETM8O0LZTMtcLDZQ9fMzIL
nmWhOI03YMTwAHjDL6ZlfyG2JngJBAMtDg18ZJ7jyko/mMMAMUGkUmvXtr1fbC4v451L/7aADXq2
YvR7dnE2bVEwKkfLeyidbVZubedZSZyNvBIPFnaLBINRb2S6RV1f/PnJyfHyqiCNLqiElw0yrEwy
jV/8DydlDOIj80uFhK9O+jdbi1TngVEJBass0J60ttsaGfJ7/kocXVrKqRX1fClj0ntt5Akr4CdN
WT4oYfugWWv4pEUzGvvFk1/nlTg7ld3Am9GcGMTrEuO2GbQ7C/CImrYfd2NUkcnQBHJITODNVjNJ
qlkZokVBvdsCaFZqLg2ky0727urhw8BLQ05DyUohfzo3ouZlxoPTBBRqGPveCXfMZR56HyxPEj0P
Ur8NgjUKnndRdGZyFgMiuyitoaFZkYY6M9W7sPjue802ZtJOT/Z6dYDp6vIixd94FkbJC3hfi9If
qA6YIM4XaU25WRgNjVrbrsnZLThqih28DQdzsp87Lz1eNvceBSvsiT6CAlsxhaeZtwceJMutUObq
KTO2ya4wadsf8miTW5/j+FVRnoLgzfGvL5tdWiWjkDoqQqQQIAbPV0mO3IdpRdFaq679gP6MaBnf
1IPj5t0Kf9NCaKL4RKORBgaTVM7ca7I4mcocU6YqX6Wad9smMTRG5a/WaZ4ur2rJlGiSyKCzuDLm
j1U9y+ve6PAWw+xkt1aK9s4Oxua2qEvJbfzxLyIVQ5MOtSc6TqIyc76LvWrXiicooCvV3NFvhc6a
atmHQd94CDhpgY0nZX33gnSAb+A9lLhg1be2seVb7pRkT6GSMHma5fsxy94u7+OSd4CRFmsTt/v8
mVRaVZdUQoDB7ox/k3E4qKgwT35Vu5Ed72tzjUVszd4sV6qHGixVgL0iDX/JQYMo6XA9UIGvpfLJ
rD6cvvze0D/Lmx3xMcutMonZUDuDaVf6hEzvPl9jYVwI/BbAZZJ9uibkybNENstHBw481jDE6lWp
PTWdsQNx9/F7/8zKbOf8tK3iSNT3h0Ddy5X31jblnTb99MNqpf+ztB5qgQIuSDJDafDc17VpjKIp
GonE3XPSO4ySSW6wFnwXbhiKc5Td+Q8F3fnVrzN5XXmwDkEQpWwD+YscfvHqyM28+qkMkXRdiReL
5iycHKgbSP25XuE4BKALxOxzPRXXVnybaP9Ufbkz/y3oi3dr1C/iW8xvFngNSAJIbNjFWcyFlb6V
646MI3acn1ICoWMWroCHlwIg6ZnG44k0DR6s84/EIUK7vSbWUiW6ktts2/bjN14iTFUZK/fkkj+Q
P1k80kRFev40DBXgeZlFoySyjmAJQUIfazVZKTu8p1zhqJ5amV0eph6mmSM02JpET/+RJsO89gat
eoThavysSJPF5LhZHGiqJNQmrfomKqiGuFkVOQ+q03cvZrpT+zXC+vc939nPmh0GJxwNLzBZvAR/
T9IfmPAwp41vBOhqbfNS2+jBoV67B5a8laYRVw1sX7r6O5M4Sb4VKHetCTrCTVE1V6GpXU1he+sl
w3HkKHpVex3r1cczPtGn+s/kLEnucnP0Mh+T8HK4jW66g/2z8bYArnZ0ErNw5TwunRCB2qVIr8MU
MJ/NaZNiyhLBEaA43qMGI/lQfr58sy0eEMae0ScVb9c5SET1jcwZK2EBHHJ43cmpEh0GTSkDNyoM
73sTdMXf7CHlJmg/ePlRaT4/k904drov0ENNFh5aS37L5OI6Lyg5WOpdM0ImmK6p0iyuUtQ54eOC
OXMeaYJyGoyIqYiNRVNAn2RYE7MbPXeYvzBWqg6L+SsfSwQ1DL7D3qlWFCOSyt3tNQkjsb2rc+dZ
/j6Kfw6WK2n3pfdiqXvdWgkNi/GHY8BB0AVmc7atAX3tKdZFG7W2XKRjHsHo7T3EZC47zFJqQr3w
f83MkTG1PfpqKw6dXPk7v3mVaBaU+T4YJzSOV0Lq0mejfMv3omwEc8tsSb4hKah7ikRvAEpUe/Y/
TtlbG6kZAuho4sPllS0GMQbhdB45tA14e5w7pu90Nk0+vpbZavdh9ZzbFoLUeX9IDH+vTsnXYTKQ
rXiIzLUZl8WFnliehRWvQdGmNvCZMEnfevnLFGtPBcXZDQ2t/eVVLrkJtUQaHiTO1MdmaZhVdpnn
R5iKSyN2C0P/5TTpNY21NcGtpdhFy5SQYlGDV+bshWGjoQw4MDFJ2/1rXjqBq63S+S7uGwQRPKK4
cvl2518saoe0zxpsZBYAYgTR8wgEva5C17jyPlx0Dt76lHiIWGIK9NwUNDnj1E90m82msZXrxtH8
5I5ksxhcHSkDIOpdVNuu2avxvd4YwbMaqO2NDZj943UaKo1Q5fEqZ8h5fiiMsGhtR+KHxFXzmXya
sTY12mawyK7E6cUlA6cSFTTRdJx3ByJDCRK7JGqSBl9rduS7MXLLXh1887r+n8lRX4NU26h59qjw
HLrspu+/LI9WQjX7TaHoHeWMofVGX5DrbOi+7XoTivh868NxmWXPlw29j2cYAq9G11O8JucZotb1
Rqs59Ce8+jYzvw2p7ybZkQc5nZGVNb0/euemxJpP8hXovQpt0DGljKjqOTsnJ1lcu9DXjMwysc4w
6lIRLR2UTPz6hyN1bvxhiQBQxvQ+uGaoCjErN4shTHtU8uBTyo+ZuzGT7phayV6T1kpBC0sBb0SK
wEwWAWveOBwVkspCoaqe1dZ3uvIHyyMg+4W/cs2s2JkzMSPSmyPOOuFr6egGhbSvpWHnGWs440Uz
sD2J25k8ZA4Bl5xulOrSZNdGr9vIdm67jpnD89V6Hw9WCl0WpqwpIUEiMH/H+WVFpEog+w/Nwk3t
nW1t4ujOzsOtXX0zi2BvMxM0fXhORQQlEBjUXhRQb/bM9cywDiIvxKqdJJ/ghnpVC9IeWUKhjRkg
g2G31Hd2l4/vQpwQI2emYKGEXmnuI53mR0k7hTmjP/K+034kY3+YyMhHNIMuW3pfecUR/1iae4kX
5n49DFhq7M8MtpCT7CTP2E3DN0Ml19uVa735NYOzdCRpcg8oFwaDunStnozxPuqZcfsSWvault6s
NcD44l7CecZ8nsCAzG+W1tJbY6jjfKMAWxyDp0Edt7LndtZKivz+3cZO/meHVsJ5HKzyQi48k4VF
ikbl+ovuTBsv2kjGW+p8saU1SZv3iYjCkiAVwilZlzbbR2sK+sCvCCOleaOOhavBfn3ZNRZONhRS
gsKWLoBIq84XNJQJhQZmejeFrcruKPfRLm6gbkG3aY0XfWkx1I5NIMfinM1fhHTUEilRLdrpfuEa
xuNqSvU7gT+vyiCsJ+aeiSAgCOeJTluBwa08TvFg1JlbeMaNlRrNXhqjh0CWHtJaN649tb9VJOna
tqsrSc0/l+V0V6i+Dw88p7AOHukh6aTN3XWOBI4nkZH5statnMj31Klc14C+Rf+fPIU9Od/3vuqA
MMVBzmyQuS+U9CgHgjBe3hYd+mgDkOjI28jDT38ytpHiC6a9lXLjwpeHXIAJa2plFMzmbYO68OhA
jpLAA1z7neX61TPEVocPuxdGGJpFKgcAzfxcpklapsXoEwjIw7xaPphQ769q5y2ke7Q9eBzztLOA
zcyT6TYqM0WLMZMP8S5rP1ujwMY2w3EqBZ1Oux0RnlIKZA+Nei3XXNxHnpXCOjnFfMSRNLDUQgPb
egQn1tBshkK5SYI1SMDC6REI8//MiAh4moFlFSxMLWbCnP5OYt43wZrw+kLUFi1BHUQluSt8J+cm
7BI5oVQiuJnVs+7dd9kbxDrN8GzXb7p+bL2V3GWh3ICI0ok9EWxPltSMje2NYZRvpnKbV/fx6IYU
v5VtP13r0jdHc5v+s9QdP+6RFPE1niFArEhnzo0yi5unBUA++hPyw6jl14NvPITS28et0Lti+EvG
99V51QaKScCWCSqORjLuqma8Kqt6C8x35TpacgoNTVGgVmDs3pWh+8gOSvIhnIIRFa3+l9z/4+vQ
CRCqCj6ITtwsXVYjBgI6s8a55U+Kca2hKZCsrGHp/ACxE6NeQIRwvvMP4jGRndM4xeuQA8kqU5CM
uKt3w5Jv07MHKQj4lNtudpP6pp071EPYKfOmZdQEEhOlf4qDbeb9W/XbNF/JY4Ubza4i8CFidg32
B2rmYtUnvp10VcU8OkPOGpycVju4av/U5I+hHbpJFLrlmnbWwi4ycCiasjKQNRLoc3vS2BklL5t8
E2diWtf+2flcLpq6Bh5c8DjRtwQ1Ii5yanXndjJNKbwglEUqWUnXU69Cs9wZa1SdS1ZowlKDZP+4
Ime7Z8clu5eMOSIjNwOC0msjmgvewAAwTwzocoGPz8tlamvBthbw90vVrpAppcZ0Qz8p9S28/ap/
GNdQaov2RJOS/BQmh3nDDXyK0Tcyu2blw3XrDAcq8a7p/NKsH+QssPNZB/rGHx0/JsKZCPvBxObI
3O+zTey7rOxjUhwupuZo+T0y42uMTr//jrmbsyxFMEdRvJ0nEXqrBTlUt/nGp/gAMUQSXoXyXUNG
jDZm91kdXXt6RNjHD78n7aGbHoK1eL7kKqe/QD13yNgYuqHM9HyjepN0jeKX+qCXxs8Ph0FBqfzf
MmcxqtJihY1kmVEs7yT+jQTSlQXh2GUzC6+Y3y04wPmAVhjAOl/L6MgjZNvicJFGNIW9UQZ0RcKH
Ml9jUFwKF6LZ9/8t/U6oTsKTUU1hGKRKvkm06Zjq8JE40W7qzeePL4hZNdpOdEyoc872LYmVMmqp
f218as+W4/8YqvBOJuOFLWktm1jYPBql0KoIvnn8frZ5YBvTRPOxpUbFTdv6j9NoHqwqRY7D3sdx
c5S1RwV4bVKqUJnfq8qLaVa3fm24pfajiuOVpS9lN6e/Z77FTcmzu275PZPhfck7ZadXyrVRZNdR
HDzWVDYScJAW+SrdpgASkRWXXbiA4BREugh+FRBe85DTd+oY9w3gxKx23FS5GpQNsoKJGm5Siazu
6+UPveBPNvFaAOAACDFCe+65k+lXYwpPGapjSDsbhzH5PnUr8WzNxuykG14eJ44XFJsqzNzJO2Sj
vy1XhwYX3ehkJTOX9ctikJWalejxwW6+SswVJdsg2l3erzUrIqqdnL+gcJiIbVmLiQScD1jhimef
an+6bGV5x0xBpIEoMgT851ZsZYos3LDYJIixKwzQJyHNp/1lI8tL+c/IXCcggExHnirx6aW7TH9I
rWM0boZ2BQ2x6M7UDRhcYjrvnQ5XmVleNFhsmFRrpB3NVaGVty0s24zpq5te8Q5qv1bsWdo+UXhh
xIRcByD2+fYlkRVDAstQtm1HVD6dWznNDk6jfL68gQs3GCwsVAAJ+RiaowbLuIyUsSjxBVO9Q174
kHs/LlsQD7fZLQ1xnhAWg5lasECdLyTo61atNJJDyw5TuNQgBoiDnvnyOvvWj1FLXPTTlfj33iYE
vcz5QoKPCJ42L7RPqWQ0jk6K1YTbzvmqazuvve71b628+ejiMAQ1tJjRIeDN437oKVpb56Q5Rfs2
mF+96spvXyv1elob2nz/nc4MzQN6nUNNlfTcmUr1ZsWE7DX5eHEczz8Tkt8m7WLecjDCzgtktd5N
edOYZBnDzdQ8mtlBCr5U/rHsbwr1xq9XwJxLX+jUnDjYJzEo97OorVrMJcW4GeUrOJUPXvhNGo5N
tAb+WbTF5B8oRKBM9KrObXUTGvKcNC5D+bWxo6NuTE+5Vu2kqnXpLK3kAu8PrphgF0A9WOP498zf
DamJ/FzcFH2fupa17+3PXrG77Hbvw56wAfEsbAaIs82ZBfKos8e8R4O5zf81xucyug1GYCArj+Ml
nwOhzZwriSFNkdm+KQpqjpolrChPphdSEXm6vIz3cRUBcIIqz4PfkWG2Va1cFllRRsUmz7ZmgRbn
T19/0KKrFG3WeA2sueQFp8bEjznxuLTMg7aFTWhjT7obxleG9WQYhWvJV/Xai2vJBUBTgmkDnwfC
a3b1QWfbZ0bAxpVobyTVQQjAGcEaw8CiFSEnwZ0k+ANnuxdUuUHZOCkQoXoaHdjNnGfJWmNjXfI0
rvD/jMx2zS57iUiLkYnDmV/V4c9JuZaVNZG3xY9Dj4F8kVoM6rznHycritqKQ8zYsXGTMrB75GkK
bak/fLNa8071vXTlCC1aRPyZNimdFLDX5xYDI8gM2eN+9dJ/xBVbW5tSupL6Ytvkh8tuvriH/5kC
EnBuCjK9po7yHHcYj1DdlX3hOgZp3YqZRX84MTM7rqZnlG3bY8ZLdmb3tQ2ei/D18koWN81EvoTy
IuqocwgaghJ6BdSm2KjqUxftG+NadjzAIxtzDcG3uBiCjwzkmegwL8IEzNb3Wspi+jrcF6O2iUD4
DIiSX17Q4qc5MSP+/CQoJGlvm6hZFpu4TamNbYZwNyqm2+R/EUrFtMv/Lkds7IkdRkQTFZJ9ng/I
D2ut/ZpN/t98/hMTs5NKbcxHHAcTnf9shA+h8zANK3XF5c//ZxWzM1PrTlsawpEhrdoH/k0bH0oo
KwIdnZnVJ7Vw13lCcrJl89QeKo6+LnWMtVnAXGovZgamg2R8M1t721jprpv0bWm2EZQ03TGenP/b
fs6zBtNiqAsusN/htVU/dfrBq9cKmitePtfQURNoCewCG0nlbK3gQW4c11qDz6z4+ByqWpp5j5gc
RhR/6zS7zt4b6rW1VtRZ9A0GkMA9UQVBevfcwzV5DAJlwEpf/ETzoxx3XfKUeP7GitfyucVdA04M
yQdjaqR156YC3aohbi4IdPInrdwl6b/WWixdzExOTIjU6OS8Rn7SaLbHaszs1c5+DMr32Nl09ovd
qy6AmstBaHnr/qxnFoSsTkryXucNVklQHoXtNhgGJmLd3viRG6+Xba0tbBYlat/v5DJn74LKONK7
6YYvBtAPRfuqFned+he5MIMK/32pWcCgUx5Xvo41NdN/JNYYunQs98inXF1e1UK9i0zyj6H5zD/w
5ILeO1vY+LvK+2RkW4v24RQdh3abm8c8JLoHR09eAw+LBbwLUid2Z3fupAzQFzPIuvGq+LVzoitn
+GR4wiaTaU60UahGl9XfpM0nRme1qNyb6sCPMdr21T5Vn4qyR8n1oNZfe4SZ0/7n5c1dOW7zNhzo
6DKWxXHLWuDDzIRWTfGcSNbKqta2cnbk4OY1pi7FjJz/NKJN0Vxb8MKNzjHoN6Pj1muZ7dqyxJ+f
HHE/KQJp0LDnjXdWc5/nn9Ty5fLOLT2gTr1ydrC7MilKR5iY+pdh/KGNK/fxAvTg3O1nQXewPd+M
OgzYQ/M6jdKz4kRuoQRPMO0ggGLchNlDkTAhkJprJ04krZc8fxZIKlst5SjEtKnnr1ra3kaJf2NZ
43Wi/w9pX9obN850+4sEUKKo5auk7nZ7i5fYTvJFyDba943Sr7+HeXEn3TTRxPhBMggwBlwqslgs
1nJOdt37JNzaGkDUzo5xovGXah+G+BOcKBi4+uMMTnauxpjrREc459yww5L8JHl6SKttb4Jgpurz
O0zearIVSlvB1YZ+Vzzn3nW4UwwI8DIXJ46BEqBbdrVpA/ZF17yrvAhOxEgHG9SVvZ+vWNMxm/eV
54X9kn2aAX1c0d+pr5soVy4jZkGRmkXHBUqR5wfA6Uc6Y0YSccEogDOL0J8OI/DbyBZYzVsxB5cP
g1q5v+KkW9sGcP8AOHect+bVQC+M9zY00Tbsqe5drNNLciTI/cUJHyBoKp5JjUGq65HfjPYng1zb
9u//TSnJiWBczGgqUWlfp++ufaiBXsdvzezOz6PLgnRKSa5E9KVOdgNBI1C6vPs8fvFjwGU9NfUt
tz7iVlC/ET2wCKSYLT7m5ID5JLarAjP6YZp5xyZ9I5SFebWGjpsC6QgFFv6TJOVz7OtKukIL2amI
PDRGDoEPCuyUc8HMGdi0LRCcZeTIDf8G7vMx7527OU11h01135zKkpQEgmDdkBpehFvFIU2ipXmc
titkbHa+ESSpDbw17wNH4FSk+KSTdbWrpO3KDOoN5T+Vd2NM//ARPCkxMHl1oNYqexEPZwBQogcI
dbFzUf00j7wEmEe4FXs3xoDtN8u7jddmb1mRl+hQupUX0ak4yZdUjUvbaYC4DjGlax/L1AqA2O0l
KJb5t16za6vfk+NoDoXSXE6UlF1KWo5uS8UWGnceP8wN0oboaHB0aGIq93+qneRRaIPZtBE5qrBZ
vhUkJOlDsWoiZfEr3lk+cu/gUUSxDKhi5/uF0siUOB1umMZr7uc2fkLEpbmydSIkF1KDpNdrxh4B
Vhvf4vTvukH3CFQulBgIAemDGFiXDBwJoy4DNRMajzAjZaZfB8KDXIcgpzy4/wp51waNJBe4Ojhc
obuu37bxc+anxwzJXP5jMJ7zzHz0gPt22fsqlw5dYihlCnRmube3RiOBBx5tpInWb73/YOtGO5WG
fPL7pa3hpF5nQ4TYmeNceX72KS1QJ08aYxevH8lrAEHQQ2UebVSUSnvkpHMG7GPognpnGSSuUQXZ
NF53qa42pjaGfwXZUtpzcnlpFQyCSItHWfv2f2M7GpeqXrm/QiQ/RxB5ulkJIazEpGMZeBjyn16y
VHM8le6UIQ8OMiAXU6qSf6uNYVw9CjGr6ONNyjRMKxCjMZ6Fm8+DtiivFjz5LludImICehHmhIBo
igbLdw0sNctT9LM3mAvZARjengHVEfRNZPivlwWpns8CWQyTY0Dbwuit5H0KIH84leOjW4tNO3ut
Dka57WPQZ5b9djXav1GNvmfIT+Wrc5szXXldpSf6dNCpKCZW8e+573M2stRLjmYVe+qmiIKcZmcu
hR9MRTOCSMaqI5ICIuqyzoojjQZ0tJei9I3pA7lBzaqneo1N1J7KeCoB4fpjWTFqeVmGAnXAQtuq
SPr+wdqVs9jzxganmlAIclb7oZrRDwRp440HjqNrYwWblMGNBySb3BsTIUBobfl3DO6ic8iZiyBL
gOWc/3fAHvFJ6HnF1DrGBOU6b7tapOIUes/sJ+uei6SIgDuMVV+D2PE1flPhAs6ESX5tQpWVtA6E
8YSjZ8Zga2gBXiow0vXH5aVWXAqQhEIlnmd4Qclnpe6QcfEHhFb9OoOBLk3moMwyIzJX49itGdv3
pW8GAIj5PfLm82XZCh90JluY2klYB5a9CbhHKF4ZmxNiXsa1onakO1tHrqA6J6c6Sqd0zZEfHFpU
X5J1uHcR7HT1gbY9qFEACttcXVZKtaDgIMAsC0DU0EghCUvHrbdKDqWmARy6HbUAlEUc/griHoYU
aP0rKwES3PRz/kL6qdI8uFVLitYzD5CRGDwCEqG0pBwArhM30Lu3tX2Qb/34wMahizIGYqpt45NG
nmppMRbEBJwDFTjB5/Iw+TYndgFtO4wyztOrP1xP8ZWZ3GWj5kioQmXMi/wrSp6H25rKZpkNn2Bz
Fgcmm8O1Sb+w0QkLK34rpv6IHsWfa2sdV/KBp/GZbOm2rAeG9C8yX3jN5Q8zaLkTZn4ymj4s5jJo
N9cNZmY8XDYk1VYK5E8gSJjIoMgvES/vvHYRZeoJfx0SGvGLmRXRmmg8gOKKRnvzXznW+Rai+jnM
OYUcL16iuzpqagwudQ9Gsfes3WWVlKIoFX2lgD5Da+65KNeYiokyOJsGCIZJVh2ApNWB+aY3r5h9
4+mGFJTiBDQG1hAuTm4yillbsT+llYkk2VW3OSbgYtAls1bNeu9XvhmVWXzXlmDJu6ynOGXSowSQ
VcgMATUbeBJyhwHtLMxRroh62uqTgOYBli7RUVgolTuRIX5+4jzzoqYxWSCD5+6PcS5u4iwLEW0/
IzI6umkfUMONLqulEukCilYQV4G/Xe4Om6ul8zbR/7iYnw0j9JOv7nYcls8Vijvah7jKj54Kky6H
ZrJiMIaj7cRFR0s6/7JzQLiiI5LQ76WRBvFyk7H/3KsK0kq8wFClR7oNgwznS9qm2UxyIdIwtz03
x+ttzPbT4uwvL6NijBByLDHvQbCQwAw9l7NN3Tp04na3FvBi0uckQ4kMiCZosI6s5CcKMHj1G17E
Kt2IhmpRgeYqGu5wHJiMl5eTHM3lLc46QaUM9NS7Knsh7uvkXCfuU00ztCR84I7/A6WCgRABwy5d
EBh+S/LBwJqaqfU8YWpxqqxditmTHmyVmnVVpNZx1PF6/j9ZcuXb4ylaRgqsq138SoHDW8VxHaKL
6qVPsl1WN0dr5F1AWv+TR5LXy8JVF6FAPERrGXA539VWUeKZh4ngdvLLGZ70yce9jyajwDeSsG41
XRE6YdLZ2DYM7+QmhM30p58crLGMyvyt63YcLOeX9RK/SnZlp3pJAUW/DZjOFb1ss/lqld+Bx/GB
349CJzookU3HtMH5WUjImHitj98/+NWzmc4/rMqIPiLCR/sFuAyApiiJaElP/QYlJYCJRiWgEwmI
yS5LUPl70QspWGtczDHLBzoe5yVHoit0yRiyOlgHYADrZmZU3vdUiHRPAxGSer3I8VL/pXOPVRlZ
m4dhMRpW/FP187JGym0/0Yiebwvwj9aO1RBmcSMwgRtim5qNV66Zi+liQNugx1nu00YWOXOtHqmb
NUHjEAanszApX8x8+JAczELiVAKYT94bsHTgtIj2Hs9LlwNBHLwr0Esdmeagyzsod8gHdC08HaI2
ORg2SF6UA4P/8Um/G53rPIvY+Ju1RUDqzzR++u9bJIAT0KeNfoB3U9r+BrDf2sWrpl3fRmRwDF16
QbVDfwVgsuncBtZu86rSgwBn+e5Cic69TnU+WydDOjkpiqBDnUPG6uz9/JGye0S6l9dJFUefqiGd
m5ZMBCl2iFjm2zQHWtmxnSJ70PhJnSLSgWHAY7cmCik9HfZVV+zBxBxUY6+xZpXnBwgDYmj0e+KZ
KT7jJOpzDcsfF+EEBNmRF6T+S4GuyML5Wfv/XF42pUInksSynkjK/WlFbAtJLXDZHWDqVs6hHDQR
lzLRc6qP0PdESod5p7VdsGxztj0yzwiWDvdmakaOXbzM5hil/oiNW1HYciJ7G+egbrJ9Web3fcd1
H6OKH04/RrooVpsN1ppDZe75rwuG37Kt2ZeANnKb9JrbdgAXcsD0bJRWH+ibEuAa/39fPemspXjq
TbboNUuyO85/dMDAWnYAlFjBc20+/087K09V12nsjZgzRurXTY91AgjLGq1Tkw4GRWNAnnTuHLNe
t8bFamKQtbeqwJ6SAFTFl3VRudzTdZMioXp2OicTzY5sfTCt0Jofx+HJKm6r9arS3Vg6WdLZK+fO
3Pgg9ogvt/XkBH0OkvV52M15+pDPPoj9Zo16yqSHQDYCJBresPDy5+ej78Zm7UQ/HWZ14mO50mqP
dfziVskxBx1yAHYQFhYsf258/5p0a7v/z+uL5x7eewhqUNWWn9CzF6e0Qd9SmDQp3NnPpfFwHEO2
HOz5OtfdBip1Ic52UMRGdhlp9XN1y27JfQc8wqGXGve2iUiejUglZeEIppACIHBr6uxWMgRkLa8u
a6ow1zPRkr8r7X4c+hKaVuZd3u7K7rWONSIUzhsi0H1J/3CtyVnt2mnjjItOjrx7zKfIsHe5v4/n
m5FqGhGUuoCuC1MUSAKC8/V8Gee1MFnmYhln58par9PmNV8+X14upS4nIqSDVxpOUsQZRNTZLp/u
OgDyAcRs41e+DutXLLz0AsEI119lJJvY+sXnRYuNAbxolV2v7TeeoIn+x2V9FAEv8vsoFgkGF7RQ
SAfNLeo+3VxYnM9Af4cKzqij0FRtyl8J78qvhZX53JwggRgPM7/1hmMVR/9dCeCWAFECh0hgMJzv
O7BTrHkT1bakIhzNa0AyRfxbaUId1YacSJETsW47UdIuiNwn+8toh5V1U+dv43a4rIvC24Kf819d
5PSnHVeTkWbQJfcBkAigfX5T5nsjf/Ppfb09Xham2hsx8Y78sgB+leczvAkj54CvQOPO2lvINjlD
sGxtunMxAqdZPZWhwZej0g9JaMSTIl5jwlMHbl2UdpZo2Mablegq1aqlQ0EHL2oX2H+w6XMzYF46
VxaAOsMUQNjgXAZ/b3OwkEzKG//RTn94tDpeXj+VNwAcmWhhx8gt4DPPJY4IfRfwk6EMwIEvOHeB
ZTyxMgnYagQZ00wV64RJgUVH0clQmiIGrndgXQ5Xfj1s+X41AYmtuf7ESsm+51QvyZGKzg+vEMNO
M78ngHIDxVMQ57uqioZ4RCv4g4Eg/PJSqkzxVKTkWPulmNd5RESMNqvrova/jBgwpnaqq7GqjAQ2
grw4kPDRCyoZybzhcZIYOMUcXYxW8dq5rz56M92jmV3FqSa0Vq/jv8JkEOdmrNbGtSCsTdKrpawx
djldgffpmNl1YLjbb8vhU+AZRDcoovJVJ1rKY9opyRcnFy3fDfOCqXvhiRVs2R0giTXbZmrW05Ks
cooxfzsLFRer/Z6adh+QgYVNsd66Ld9VhEY5ST9x7ytx4qjxXgzSHvLBCkZn+WS1nxNuo8oDxjXQ
LX3AoASUJMCzkJl414NDjZK2Ls4md5KrYYDDzsZ/uq3X+GvlqUTq8w+IriCPOncB5oCWWGrAhTrk
8xA/j/RTXx+2X8n69gF1LIDamQIy8t1w7eJ3s9Ft8J9FbocrHoS+iyFEXVlcqQ2iANA2C2BCuRQA
5voq7WxIIU7xiG8JCzAsxQB2qcrmejR1l4KqkQQdbH/lSdazNdsGV4ZwCs9aK+jJry391nDwk0/2
HoWYu81cP8fkxR360Cl1yNnKQ3IiXPJyBTfmskhmOFRS3njsuSLxc5Fuexcr+4HNO5EkObeWmhuI
g7CsTXGFdo01/zbpxiGUyvhiyBKwDBTz6ed22PJltocaymTpr55GXr3PBozk61B/lG76rxg5PGmL
rGJ9ATFkwLxM24RczJJ85OieCJGswh/92cp6EWQvz91yVQ5PeXL8wI6ciJD23mjKBDTC0MNkUABc
RlaKdmWNc1QtFvCS8aaDLwZNuLQnSVVMMW0gpOluwbXQd7epjnFB+XRE4QcOSED4AV/vfN+zlpSF
ywmCHu/ntH5OUjcABwNmLO8n+AmeB1b+7FUfKI8Anf2vVOFHTvJXeLisPjhfcLGBNGAkoYMe6Msb
pLBnKISnP5pAQcco95N0KKTjbMKv2tx6KSheJxlNfkycobtj1OVsFG4PPV22iay8idhbjuOW1dmc
ccD5NMxfmGSOnLU4GvUaeWwIaP7zsmYKqzgTJlm3yxPTShcIq8rrifeIPYJl0VTKlKt3opBk3uAz
2ag548m9oSdms16s8qnANGpq/LqsiyLAOdNFcmzLYJChxV/Q0PMXDPvu3REZKL+Les+/Wyf6AvTy
nZPrzE+3hOLnJ+bnbJY/L5XYL5QbHbQ2VA3gMTUuQny7FASf6SadLM+bEqCwQrcEQAaVB97mUddG
pNNDOkYTUni8TKBHzukNOvAxQ+BDER1LtyJGO9NE/PxkuVJQzzRgM4Q1uAdnvPXGPe8tcZ4CNlZh
o7EJ9boBshD4lXgWyTfRWJkV8wd473ZtIjrcdJmOkEgVNkChf0XItxAbek/0WCNrkQbTEvjmLWch
AFtcACnzIpjMEOVBRydW7SX+SpUOburPxmg2kFp2LBjoY1V9bfntnPIg4Zrzq1lDVzq/lGfF0IlM
lgNg+WU9eIbuIlef3L/KiC84sYnGmJt28IUEvO28JeDJbskPVSGA/wHifFjqq8uuQrd60pnNUErj
WwWBANDF4N22PWRLEU5ZtNBvlyWpT9Vf1aSDu9R+1VcEkgDhvE7IOJlBbWoavFX37pkJSke3s+th
nDIRCK3o44yc7K2vv40Y85vJtzqPViuYdZBLOqOQjjHmoNCfbEMvar5O8TdtGk23blK4YnYzUMo5
fv/op9+NdbkChNjb2LL95e3RLZ1c9BlBjDBvwrjbxMbUzx4QS0MCcEdgm6Z3Th3V1jXT4WEpL0Qg
qALhlqE99H2eE5d/bMEFeksSZRU5UqRoXOOni9b8y+opd+lfSe/ynb2ZkWqaIGntMVrUN0E7fMS+
TyRIT87GdaeJCHfeAwrWnX+CNSnRQRIpr4wTGbKv87oh7yn2iJVfHfB6J/coU/NyxJw8ek41S6Z0
DQKQ3EVfNJDmJddgGovbYUoWZ8l6pGYZmF7Eh9sp+9Qah8ubozTxE0mSayB+Pk2FLU7t8ERYxMjO
b3WeQW0Af7WRPANNrKzZFmizGIgZ5p1Bx11t7cx2DDozbPoFTCHAjUbv22tRfW3mcJk0J0z3BZKj
AD4fwssRWg7NL4f+RJnz8ioq746TVZQcxVb6W1xxoWH9mixPvgmajId4+sxZVA3gZGh1TdAaA/Gl
MjHb6tiuwZAXJkBjc0kYb+GSAPwrDWdduUInSjpcztJb22QKW0TKzBD79SVbv8zFNdPBkOokSUeM
YlplcQchaTHQtXqTGWloDoHDf3JPc8CU3g+IwGheBUAkUp/nl323rUB4xXhnSLw3YwRJhPNjZA+D
rjdXebpOxMiny8rKIRE5qs39jtmQebl1Yk1GVWnaJyKkwzV6szm54vG0eM/p+M9qHy+btk4F6eiw
vHOAy4uVsuo8IEUSkelA43/+NyHS+VntzltmsU7W7IBRrML8/oEmX/4nIfItW/V9PuKpjKcZ7qHc
2m0GC9xMB8SmWS/55dzPNLcHkcAz3ZfU/pYlh/IDKFLY8H+N15Ni4c5DJ6Ynwh4MeIdsfs3mLuyb
2yK7NTFKd3nRlJ7tRJYwv5Oo2MistHA7yEra7zFoebaufCU5BZ0t2Y2+H3VdtWdO9fWyVOVleyJV
OjfjaDrlJl5MyfLNbl8MwFzPvbMvTRNVJccL6qLQ0UtqPIKMOtmkc7x44n4fW+D7p4Ef74AtFRi6
Tg6dfUjnyXXq3uRCNWs9ejyqljctrrtOhHSaxn6zCa472Ie/d/lTXf7QtlhrRMhJ/q72jHVK/qzW
53J68IcnO9M4NrUItIqLYiLiVNmxlXTpiDhI6zYFaX5VxC9oHrpsZ8obh/6VIW3G5FgxNz3IyMr1
JavGIOP2vuBx0LbN19rWNSArzRr1eKBuATEY6YDzw9T1DP1PFBeci/kFwIoF/rSf+yzq2us0PxJd
1lhp0qgu2+gKxbCHLd2nfbwV/upCXEa+2uu11x3TJqy84+U1VO7TiRTJQ7CiRAK+XnFw6C36ZQh/
Sw2NCGGw7xJPmKMBGyv0QEft+botfWk5VYLkaompMnJlFrsBaIMWj4bkYLs82Iq3D+h0IlDyP/1k
GQU1oFPprdatg7gkjCeGOgVZdaguyuU7ESWZ+ea1Rc63DU0UfvG41WmYJe5NyTXjeUpTOJEiGboF
mx6SCVKc8uBRIDk/VOSe6TrTFYQSokHs70bJnscByjv3IWbZkgiDhiXpAye979odb15nzGFnNxg0
yeKbeXhac4Ac7P0PPWhcMZUEBBSBsinZig2IzcURiXhkyCm/Zes3R+c2lPZ4IkNaTYpKuc2QCxWP
ppRGVfXDHb+P286Mf3X2rtNNkio370SctKqDkYykj6GSbX9h60/T+uz4N9oshDKQdIFgDghMpP5l
/EFvLVlTi70bVh7O3Y801tig0tJPBEirttipnbUuBPTjoaiuAckEcJPL51blYPFGB3qi8OkoDJ9v
PoZGjdRL4PHo2tRPbTpe+wztINuUs+sRgyX3CQExgGUPOsZQ1RahbcxD7xB6d9+RuVq85syvORyG
8+S6j+hO4tZNoXvGqlaQAmWcYvLcwnyRZAig6zHaLqXieFlRDISfhG1gvqOHy6uosATB8AfMBMzx
eig1na/iAIxhI/PAk04wDwqwlpgEwGHTQRWJgyg59TMp0r0x+53LJwdSMNT+0LZAQe3KPSDunwfk
rR0kri8rpVg7cNxQoE8IjBgAS58rlY5laXtcMLFP6a7ph5905KFjEE2eWimGIusInmuQccrhvwu4
ZMADgOV6ztsv9Yw+drN/8HVoGqp2eeQ2Baw4jA02Jz7jJCx3M6didgr+6dir2c7rivyJOOmXrUjy
XUan2ypu74vceWvQBBjMm3MXJxUNyLh1AY87/1gMTIcqo9pPC8TJovELFCIygMA8W5gf7kAPLRon
F7/Zgnp0zMBFvBuCQCkNckcHwKYUKfB+MGKP9ZZx7FLuJqAOrKqQ870/Xcesx3/fVtCitrq+fFWO
FnR3f2VJwZSdOXPu2JC1ApK1Sq/qOQ+GLCTb/bhFlD6ugBPojd1lo7UUfuVMqmS1DhjTm4GXgCeo
CoHPwt38zjKb4Vsce+udN2b0kxk77He8cK/dJ+ME5szSIfExIeb8uKxljbqCZXYodHJy9M25n8Oh
H1C7a+lkgszT8M2f6ZA4uyVL4FhG9F3zoLRoexUXWfKS1vZaRp0xpvssnpkmb6tw15jFwolEqyDG
bOUGUmo2i2EIAOSNgVSNPk/+EYCEqX1Y3Lt61nQLqk7mqTAp+F4SWK4xQRgmYi0rWIye/DYxyPw0
GVn59fK+6WRJ27ZmRtF0BWTR5Gm0j615iIvwIyJEnyo6lW1Xtn2rpRiHmHDcSvYPrx9A+a4ltFJq
gXBO8LBjAlueXp/8Js+WHk6GsPVQLCRAKQG5TF3XkWoMGo1V4PQGmyna0+R8hlVOhTX9Wa2sCdbV
/pHUP6upvLUwmDet5a/edEPTzkNWFVcbOGOSInu4vJim2BD5MqKC4xQ3A3OY7E+LkoxmT8WGgXtg
B+aYN+Iby575mHHoyhxM0sx+Jr1XBoRkN5xlxlc3L58qc3J2QEgxNJurcmynnyPcwol7r1hrZpvw
pTNNgwXEB8V2z8bQLK4r//Nl1VUeBnqbmCPD5QQqgnNRNcbc06HIqxCDRxh4mJI4jGu8d8y1iPHq
GYxRV2hVSgRIEdhQ0SaI6/hcIvHqpaBCYk5/j+ZuQdW9264cXQ1FJ0Zy2DFoZRezhZiiuY/zqI3v
phzmpcMKUFsvKN9QCnRwC/liL0/2alrKIhu6ogqTws33c9sEuZ/f5uv62Z/e0rq868sp7Ej2NjnG
vi63I7O+XN5CpbWgc1egabii2e38C+ZkqGab4WoabTAxvMKWA94c+uxXpeuiUTrsE0lSzAZCSnBr
iUuwH1nkF1/SdAoKToIUb55sWo5tvGiyQKpYFNYJPh1A/+OGkHQzknXuqbgAERDzoCr4GvWTrWtk
UHk6W4QtaBcD9tE7k1wzGwSPNVawi/LihWOKlmzR5V1SRhC2TcTkD5hFidx/i15V1+4MBLokAdrQ
NV9fJ2/fb7ceMP7AAGG6kasbDVY1I4Pe5q9MyZEkWQyOEx8yLVAeNaAjhCdrv8/0nsb7zoo251Pa
hSscnfGls8ISMBQNicbq6DRHv9GF4AqGbwyrohyFoWgBwyQfFb8exKMdX7M0N4kfMPt3zB/bPDDi
YLGenTjYkp0JJpv+EytuaBPFGGztrqdp1y5fy2zX5PvLW6IyLnT1/h9tCkj2pPeUGVdGT82hCqeZ
zwERAerYNoNmCEvliGx0PIIKHrYFbK3z4+nzBkF6OVUhI7+34UvruADB8zBI/4HuSlzWAJ31beQW
kfQ7FzQVw8CZvVTovD762O8te/B0Q9SqkwJnh7ZAkIYCukdy3kPmNROGcaqwXtmVy7o7tzGvDHPQ
BGti5eX7GKireC0BGEVAsJyrshRlk5Q+erGWofazYFtM8mkGxt11T7oqov1IHufJmq6rdSROuFZp
/XbZNJR6UrFbKA9S/Dn/APA2ZZsz4QOM7pjMX0l8qHTbpXKmmMz7V4T4+cnF0bV0xcsOIroqxRG4
3ZxdtkXJTND85gGmcPcBjQBLgmc9VhV/zsXRrqCD1wtxsxXalX+XcrZbs+3pshilVidipGt36tC4
MHawdkDxAZ/a7fugNt6c4bNvHFtts6/4be/s5ESaZCdWklmbvUAaHvZj+WUDjlRaveDuTdu30ds1
DQm836Q7An8xuKznn+j3kmjpLiTbEPfNivVs04NFrud+l/p3tRFW3SEpI68rDz25dto+GOyfsbdL
7a9pf4ynh0yHw6/yL3h3CzR3l2E2V9pY1qGzlXlYAyMX3dtXbRNlyau/aR5rqhOBgA1wkSCXx7tD
OhH+UnarCR4IMH2bh56be29Id2tMNWaqvCZB/4YpYwvMUqiSnNtpwpx5WHpxSayA0NlVS8r+MeZ+
KoI1tvJ472dTvAOW7PhUImR1w7lGrRRvgiodNTe2SmOwtwEjXwAsILd3/iVmPk5uXMww5WXv0291
FRBD12itOi6nMiQDLtCV16WbuBySaHODwrqySoBWNnugDTgfaODFQDWyX+BUE5soLe0EiFBchlCo
33A9TFYe5FP+Acd5KkOOOCqDIxiFjNjDaBG4H82jNaQ/3Gr4SPbnVJJkkCg1uEZS47orPw/NvTN+
4tsdyT9lz5cPunKHThZNctOVt3To6MYOxcVzMthBCf5oOwLB2mYfEHVr3IrS5vCix4MM8fw7Psye
jc5YmmLgh914+aG0Hh0dVILKXwBN9f+L+HMAT+4da6V9t3Ri3Za3bfllDZHZh5VuDEwVW51KkbyS
lVkFnRYoMoIR25qGAAgWlzdGtVTo8MSQM9hXCcAEz48nK1qkHJmJUITeMoybVmg61aXCVXHIn0w4
gXdFkko6nj7H9NmA4iOKIsgrHjaMY1Z481htEvD2MNZFlC+7y2opHeCpTOlicerCdOAF4c+TLbDr
2zHpMUp7Q6r9soZDcg/sDLTMXRYq1kq6zDxBkksYJaDzk+8QY0zyHl3xeCeg+XkWcGXV73xFZbX/
QXXoB39SCufCGLBzRb4P1VzMCUpuiCXlVLszZjEnhto0piAdbw7WYje7DhjxfnkA+FvYl9ZcAz9J
ESfvi7UKCv8fmm93FVJE03Bl81vffR7J0fGekqkGE2kZucDb0XV9vl8X8ak+2LGx/wxE6Oc2RjJ/
bbcKn1oOu2x5MquveLzNBG8U/vvyDrw7LwDeFYyk8MsEsBfyE3TwgX07pE4JRlLwxXebPQZFuel4
T9+dGSHFZyLlCg/zbp8x8N46dYbyBObct+uhGV64b4EUrnZe/rs6oKK0gGRPUUGSc3ozHePC3xAt
kDT5XiFdtllJeFnEO8cMXQSOF/L+qFKZcoNIPRq0RNYDCd3260qfxw1Q1zwwkySos1fm7C5LU60c
Mqp4xmGKw3JlZABat2uxsR5lqqx/ZWZy66X9q5/oEP0UZoAAXUznEsxe+XIV1gSzWFYlDaIfQt/c
dXgcENle1kQlwmIm5vCE03z3TCR8mbiPIxWm7eSEwCgd4Wl0MFjvDg4G/GwcbbxHAZL/Lj3dZxg0
BkZAFZolQvDlM63HMGFPhk3DjWoKy+8uNMhiMAVgg9iC/lQ6pFlczf5a2lgzD0mEfwwzqraHib9e
XjaVFAfoNwDPYEhd+sJATq7NlS1IfjVMpG/4Y05/YFLprq09MChuGmf8PhsNhYAsjnyUOKJIT5yL
6uzEqWoXonogNvPpeqaoxlz5zZVh35gs5NvOQbIkX77m7g2alv67nnjYo4THUJQBaMy5cH8CTmk7
VzWAuJswdQ+ud8R7MkBJQyNIZYdgT4IBonMas8tShOBR0NX6KwShwSsEj/k9T+zHy7qoRSDcRT3S
AsqppIvVkD61AV8I4tjk2A4LZibn9udlGSq7EF3EeHvhnYAJ2vP1SlKwaYBstUYR64eHdJb7tQdp
MfnPJHKwCWwJgeXB0vHYk8RMebH4To/Vsm+azr+rbDfCrL1mTxRe7kyKFOyi3LFQM4OUvsXQftaD
rMD+VdWVpt6iXDO8QwSuP3Kh8vDJmLHcb2aISZwvGdghyzjohkg7vP9+LE4s2r9ycBmdL1rrjA3L
F8gp6yEyusPGv9HmekutIHVAierfN8hOdGGpgypSXE1nciXTtjq/TOZYyLXHHUbVwnr2g7z0djO3
A5s+EeQJ/rMVAkTYZOhxALgPsmbnmtY8zkY+grcFvgu4ZE2QjUsQ09dYN4in2LozQeLInbhBB035
Jl0haKBl9exm1DqivNvcrH37rQDctEYvxUr6KEuhlYK5GByXuwomAyPjJoWTGNriFbhm0ZhMU4A5
rCAn9R1FUi62LY1MlYogRcL7GLGF9y6hUrgmEJHzqQ4pdwByNgdzGvk16B06TWZYcdrg4f9gP4tr
Rc5yZvPSd54L14Ec/bVX1WngmKgFUFeH8aLSCMGrC9J7sNUhd3u+af5K2nkpoNGKd38GLl7/kYIS
paealVMqdCJHMo6UGLYzZzN8YeweMjMJLbeKimHbXzZ21QXpn+oj3cU8TpGpqqBPvNVRUWwASdwP
7s5Zw9a5Brc6B7JvZ0QDhjen7Saj/7XJR7yVMOwIC0EgzeS6QQ0UYTFNXoc+xghMo9hZq70zrebp
spqKGOpUjDywENuTWRolxCQpnkHxt4V2zzZpotEyr5pWZ4xKaeIiFilEFBGlYkjGO24s3galYBak
bW6I/SPLfifzEKV4/VxWTXExA+UZVSDUg5htywZpGgNBtxBUo1n9YFT01u2+X5agNMUTCZIpdmTt
k8qHBDefwzqZg80cn8BQoTFFpSKMASMB7DsI3KVVG7N6rWbQ74SDlzwSlz/TTDc+Jw7n2XP5z8sc
DE0OXqA+aALOD2+T4X9XDYOx8/gpFn1VzWcXyQ67Dbznut4B69K179zfBID8dTUeLq+jynWAgQew
wiLEsWSM+toeupitAFHPvU85clH18jObdjHZNK5D5eipYG6Dmh5g8aUj3bNqMa0MLUk5de/QFR3x
xgnitQh8vzzMnhlkle4qM5W6IQHhYwN9FzRD5ytbgimxXmy7BrokfbMTfnTAIvfNLelNO7K7ehqc
cLPTz07vPmULXwJWpOaxtxdyHVfdkdk93bdjVwWJSV/+H2lXtiSnrmy/iAgkEKBXhhp6nt32C2G7
bcQMYhRffxe+95xdRRNFbN+H9qOzJFKpVObKtS7v+ufuAj460ChIi+cOFOjKz38a+l+oO0Iiw6vr
xmXCcAfLdK0e3ZRhTI60DHdsALWUVncuS1KPADHDitsUEx89YOt9Pbg1+83qrYG2T/Uw/Cxc53j+
MhxauizdwP/DIRFIqIvW9tErxdJ/p1WzL8lrMXlaeVvl/uWdWDvHNgNuE5c/hzb6wvsrW2vROc8K
j9R5cqj1zPRSQ4y3pZFZf2MKC0T2xMGbuDzLphM3YcGxuFJOt1yhKT3qL5Y9PF9e0WfwJmzYsAIk
Lzocn8BGaHhauT5npROkQO1UvPZtfNv0v1T4YQzD0RGtcFmne+jlPpN4DBjo0X2N6tCW6chGwr/2
QcFQjn1FH5yxJWJaVowMsQrx1ByIazQeCA+jegfZiRCQPMVfOrERMNfOHBjYoYqKqxNk7Mt3DHhq
Y0tG8CAauWH3w7Z3RTV58RY+bnVhJ3YWLxmntoXmlBrK9v1rOz70xVFnGLdCe4zfkmpXDX+Ry4HI
Ecxdc5hGf+X8wMaIklo4CBxYB9ziqK5r2uA2kmyEybXjcGpm3t6T9Nts26QhUAUFwdDDYJdui0EL
ZwsTthaLEXrwmebASJfNb5yDPOddjDM33oXiNpdgvLYPXN+1RSC2NLhXV3RibPGhhC7LJs8SXG+m
7tb1NY33DSgrL5+5teTmdEWLSJ82UQMkG1ak5E6zO6/AIKEob9r4lfZ/4+D/rGep2thj+G7IIpiK
yNfKOYzpo6Qv9ZYW6eoxOrGyuB8sPqRjw2CFO0defVHVPbDm/bBx+a8eIpQ04Ad4g2H0auFtUdYn
cY7HXmREPu9+6TRGtfWL3YDEQYt3xNA9R20lomsOMVNpcQjT4Fm0jPhxUtJc2nAIZPEBz2o3kVHg
bNHD/RmRX6ZVp2YWCWJLwJejcZjRUC5/7VLWA/PcxG0S9MxWzyYmA8MdyKkL5gIi0uV+RXj/HVfy
4CtOIgzxOX2meUgJSPnkUK19GzsSz2CmhtuATEu4mhJAOnFZ2j9yNfGn3pJZhYIDcZ6TMOGPowVW
nj4Pm681/hd0Y4HceM9qKPG2oozSXaSZfYtmE/gzXNGi3/UoBxTUfNxNDUhckxok3NTQ090gRqMI
hmEwm53dZBZIayfDb6RdPVRhPUGgNMlk5nZVa3v2yKpdDdxCHrWYc23MssjcUXQVdxX6gndctmRy
LWssPjRIg74rPW1jN7YBYXTBT4JX1WhOSKmbOuo8M6modZX2tuFTO9Kfh7ofk9vOVNYDETkfA5Au
DFFgjzS7B/Fx5wO3HFmuMDGHZmbAMGHWVg/fRMVH+1bkeC56yWDY90Tm8igiae/GpEfQDp0IKU/d
OLmO1Sf265DUUet2XZ/tiWzLXW46VbFLeNug2xibwzVQkeP3UBdJ5w2jVkFqiFbZRsKwdghPXWgR
8+U0TJDvw/HI0TVrwrsufLJRW3LSl8vR63NLEBkDmlAzKTHKBJCmOj+HTaKbgsx1TDXeF+UBpHmJ
vlP1K0hp3Sq5Du2joR0u21w9hScmFxfN6PSNXWgovEjAkCtaC1RBqseomr5etrO6h+g7oh8N2BrO
/PnSeFNPfZHBTjvKwwDsf1knr4lhPVXdsPG51rfxH1vLzveoCgj3zhXnyToQ54euHlsz9pTz3ayC
aQqaFFLpW1owK4+MGVaNvpGFejrmRxaRGgiPSAIgjFogv43qh3K4lePPSHxXpZewncKBjV9wzl1M
tdKqdUvqx+l7m/24vM2fI/n5r6Dn24wpJCdsBX5FnwLpGD5LlfqFPnqh8Ifqi4i9uNl4t352IFg0
2IxKnomFl+suGOZaY9EWUCVgXlVrOzN2jkO4ZWalxgs7eJCgm2yhq7lszIVDb1XZVOImHKxnk0Pj
txfy0Ap+ZRloFuc0HTxh4JHXxvIYlxDHAie38+9da/4V1sygjMcaRhDP9zckwCiTFDl9Xr/F/Fcq
lGtI7Kr2Vcu/9+oOY8Rq2mrVrG7xiVHz3Kieh1kkTXzUkU2HhFjvreh2pTQ3soCVc4PFzV0HlNMx
c7asQOjoEYYlyFRBwQ5mwfxO8pccN39+70D3QgZ5c5uHW2Dhz3FhtonO4byluAcXxwbKOR3vJNyn
yX/JJgVl+V0YKmAJf10+GKt7eGJncTBCzkuV2VibbK7K7EebB2R4vGxi/gznmcb5Uha+ISGhA5gK
ltLKx0kv3REE4pctbG3WwhEc2thMFFhECjQ1ovYxjZ1HGxy+mKvZMLUaSE72a97PkwdIXjkJuipY
TOHca/aH1ljuNII8LHRDcjOQ0G1Ap/PvV4cTNaPzIQUCXYZzk9you3FwUO2lrQnJnXsV3xV9vDO2
eFXWXOHEznIcbRCNoXQBO4IU15CtCVor86cs2ogVW2aWnj1mvdnpMNOBXIRj3Ejk0q/yLdj558EU
CIwgEtkWNGNnwt2FHUC8qlh3UAGt4mFC32QIzR0FRZ9yx7Q18lsMXaF+5dTaXazHfWBIVXxzhry/
ps2sADlI4H8uf8jVlZ/8Inr+IW1Dmkik8YucsH8uQ/LR2KZvl8+Xrax56Om6F8eNFM1UqRD7aw9f
eFtBtQ4DqPUjYAdCn5CcvaN/ftni6rocvJRREpvTi4XFqIrTSlAUgePYCXdJrbOr0uhTNBmzLYLw
tViCqakZUwPsJNLB8y2EvlsblbOprjNuZFg+xIXlXV7NarhHW2r2Hoi8Qur83IYI06SddHQCanDx
RxLD9AeqH9p+B942wh+oJdy225jzWYtg2D6A4VH3RJK0sKlpHLIKI8q/bIxcm7ReNqljbpqBVbQb
X+tzdQMELChkz1A3WFtiuuyU13KKaYHWXu5Omj/1kUusr5LeFsNVIV8v7+bqwk6sLcobdj60U57D
mkC9y4HeuN6i8tC45RZfzup5xz2JXBMlWpz6RZjUJpk1xbwuxXQQNbc7g+d+DORl22heYhN/UF+A
4vZUPd6Gmb0LE7XhOWtrxQ9A/QuwrNl7zh0nz8sKkli4hgTeoWH+s3OEnwN9r/N44xt+rucgUKN+
inYmBHQ/4fImJ+VVPDfY46a5RYlc7MPc6fxWgRaWTwpNdiboy+UvuXbKAQIkuIdgEVnt+eqqnlc8
1gH/jSwIbsk8a7yoHsKgq8ivy5bWItgMzwNTwSyIuWSn0wooEXAtL9FfNPp3XU2DhM4xsSF31ZjO
99JSzT2LowHALbQn8RxEXrqxwatptW1hg3Uwqcza2eerZXFvRWNqoxhehK5hDGjnPtfcHYtvTN3H
6X1l3lvWfqrb3eW1r+6yhaoPhGBRP1pi1Iljd2Y0WEiWtO+aCUkhvOKLaONtslKCJ8gkAB1G7dvG
0OYi3FgyzCkDltSzqXCl2pflw5g8WjlqP3thHfTmhtLdFJvegDyDfEXV4fIq176wA3SBCX8CRG4Z
7jBb5BRARc7ApPveGXYz4rZ9YM6NkRyHMXZtW27cvWtRD901sEGZODpY9/n3dPA1SZNhxaPzfSJ4
mDzkALM3IKKyRz9qtkhfVw4oAgGefXNAQnd0EQpoXVaYzapn6LdTX9fKdKASJwVolc0kDgwUmfZt
6zThxipXkAG4+tG7AXINrLbAY50vs0xol+U57BZqN5r3A3N73mG+uMfDF5oqt5x5nfPbQR8NDQqf
sH9NxD6PVwEjinlVTBbi+J7bD8HGog0tqI5yejXEP836UUQfl31nLdCf2DCWqCZls5BZEjYabj5S
2rk5lA1G/WfC0hsgEg7oqX9rI/UV9U2XduRYpVv0oyvOdPYLFsEBZRykxg5+QQlFYA6+tKa5A9vO
tdWOPgPKTsXJVjyaT+TiEYVm2R/xCAwEfgI41ZmRdhMxS0+rosnaa2yQ790UhbME4NA+CZRvH2td
Y/mOMsi8uiGzo+iGRGZ6sKuyN3ZdZupXCXeGrTGhlZQMLL0GmqIM+G08j88/uTX25VjOBQaWsL02
Obsq3kJBrZrAWcIAAugyPkn39FaeKlshGINX61hTVH2ByrjsVSt3N8Gg9SwwOb8YPr3xO1XzqWN4
LeT5gdYRVPxuZExdLsKNT7lmCZW+mZMOseETwNQqkyylESJ8nAyo9kZ+ya9Y+RjRv7GDHA/UFQaZ
W67n38XJHLPBHYDvkuvXRP+p1/WhGRFpE7bF07J6JE30xNFwBJ0gqiTntqhmVKaw05le7y4cXlGP
cXVxIFkKKZV7rXy1uuuOXeX9q7A2wM9rR/HU8iK/7AsqYyGRlejq1q5vSXGkRPOYcWeLVzIdLjvJ
WlYAoP2MErLx1PkkupSYIsqVXpZexc0bs6RPqn/hfRVEUbmrktZtjeFW19MbR3OuGhJ+vWx+ba1A
8UJCwZ7LxX++wkntIe5a1kFYbr61+ZtiwqWlAbVoBwJs+juc9bqNtliq1leMTMSa6+6YNlqcbm1U
hggjrHhM2cuIQU9NEX8kbeqlVnRjkQGTK1BcrQyPhR+5uTV2sJapQHYKz0r0yoHAWV4oRiiI3bc4
LWVz41TI5Y/O0KDJrID/Pjg8cPieh7sMLHQJyoC7dIt8bu01SCwosc5sHUh8l6NBksdh00Eu3RuS
I0EjqgUwwNR+C8QGSztk6miGt9A8+vdfGsBd0DH8ASYsIf1AHke1mC8YzKAnN2krc4j4tNUtz0G9
3sV3dhJ+71PebjTx10ITpmPAUYDRBVTtl/eaIYsspm3pmbUBneLCtS0ku0D+6Bj4uLzClQQJTBBo
rYLHFzjo5ZhrWJlSt0vMxvXsJ8RB9uC081u8C3krjzZI8i9bW/uKeE8A2AJTKOH+6VKcHJ0uC8Hz
zvGkQOrz/EfCmkLoRE8D4tT7oXnoue71XbiL0Ia8bHplT88sL0KjVkLtZpgfM034MISJ1xaALWXR
zrC3+E7XojBM4fKa1S7hroscV1MTxl5yxId2Mq5M9GJx898ILfKNSgZpbrp5JXal8zRZ4noarH2j
b1VHVxdrU4QnFCtxaBfRopjimooCi520b4CQNVrjVu1Tgy7z5U1diYQYDUGvASyABtrPi5V2DprG
OJNIc0l3JZ0+QKj2rJr81Ir2oOXjMQu3xDZWIGmzFBQuVPSy8HhavlnMyrZB+wubaXxk4HthVyTa
y+yAt2fhHMTk5/YXpt0UfEeTV4hFuVDOZfZ9969ZdJFX40EBEhXc3iaUTc/v2s7go9AUfkeC6kK6
N40Xm906MkQr/ppnW+Icq1/0H2tsMULQj6qO0WjHTkOYoNW/oNbgj6PpVlshby0goJiB/UXFbeaQ
PF9WmFE1dN2ER7/eekBXoNnSPRWkuhZG+jRy+XjZg1YPC4IPxSgY5ujQaDm31+ijHuOtWHqEK8D4
Kshy7NJOd83qFkQ4YPIN46eweIsdkNzFL5eNr+SzqFT9Y5ue24aAN9ElmubALUbAiic3RGzhVucT
sHgvADYJzCBqH2AzXdYvIPVVCScElWSmOYEDFADTFbLA+Hh5JWv3M9BeM5YPo6wzZuV8KazDsLvZ
opnbSF7u40iY7mTm0WPuRNzv2ZjtRVfeJrYF4wDRNMpMXBEpJIYRewW9envsy1xtJPN/Lqrl6oEb
/SPugjm/JWAgV0gakg4fV6KS32fEHaBkXbMPzGVem/o8y44AbH7nseVWTO7NTnrgVj/E+YN0rEPK
WjdE7zSx4uvQsfaCaoDUb3X41reOGTb4O1ChMpczK33TJZHi8IKih5h8ctWl70noAkoCruLXxKyO
ZvxOGsOl1vBC82yXJNKV+ta0x5qjwD3Ako3nCJLbRSjFByFxiracFxsY1IlNMh4ARgYyvZEbqfq6
Jbx7nD/jin9SzZM7GPW7OuvmJ2xi0oNDxKHps8DK7P1ll1yLWOjUovPOUAnG2Pq5R466oSUYVIWy
D7AoVXOI048YI8XmFlXBagSZwdN4DoA76VOZslAY42oTDEeXdRjSQEDnZ8d02SKR0PrX3lH2F9IR
csiFXd00dkNuHEuSa7OoQKpHeLQV0eZQvHR6PpdfAGTFJOiyQAuRZmqwWaqikW4f34TlR6f9pm1g
gzaZ7utin22ds7WtPrW4yG2UqGTDZ9HMpPha615GURdW94Ox1ehfuxtO7SweeWEe6mXTwY5Gs51W
A3XGR08bmyOktqGUIjbCx1p2cWpu4UGDIeIxHrCRWfs+SbAAVM9D/KRrfhmWbsl3l/2VsDncf/pw
aBqgzz8zVy0ziynJE7swcMeiBAJwZi7HUe4boL2aAEfGupItrY0gAqh6p6BW/aZXkj5ojCvjqrXz
Hr3Kiow7KzUg7NGhUBLtzEmpR6pK3faMyTCyB0Sfel8NhWkf4jAdv6cE8wUeU5ERiClCGIycKL1u
at4OPsXQqAQ/f1+KYGSavMr0Ugvi2W2Ngoag+Ol08sFbvTnQZkiVr+dci/1eJIXtNWPo3DGtTgAb
JE71YESm/lJTkr0zPQcdl0acCVl+o0e6Z8YkxChi2SbHLh8M5K2Kg6MNU3T4DU5319uhwdxM16Lv
RMaVj6qnfDZqY6h81dVD0CWt/g2zCzjrph5bmAzKI2HtmKjpVTRANthtq6HNvLwZmNg3OYABADHO
rBIkM+e5LP3Aawpizzbr6OTyagS+IxmLGqEJTPdXQyo4uAujxPkoocjhqc7mv9OoIsfc4PEeVQLl
8wzDWFcA1YPrqQVZn1uX2GQ3ahKV+FDs6zzgB6E82Olm/quuVHdrTbxswGWZhB1IZTvQaUCZhf3O
edh+J3GrHC+NGvmza0jxXEI5KnRZrRy/dTT+O2PY3ie7tKM7yGjoiReprMRwhDndmCA3DnqZQkiB
4NovBu7s+yKkI+bc22PedsnVNAzFEYUuetRblMHrsRpilxYCcreygYdpEjDKK8YUuuMFK52Aan0c
+SBwLEBH14e3Oq00eVAFsSM/pbp2m3fwXVeVtHynUgEEEwIvaHpSTXXtD5BdKx+rMRHXllSG6dXV
VGN8Z6zrWaasbFgwpiLaJWJo7jQ2kWdTjvEEEDRE2V1qlJQ8VKwvqqAbSBfdaq00bsaBNoGBJPgH
ht7rPQg2AFCt4Bn5xhNjNbzPkx7osyGiGsuJYylbeE8OReMEFGsh3Yv6lg5f0/jOSN0iORjlbzn5
yrixnM0B+JWAgFcNajwY+5x53BdxtexbXjcpMgNMCt9gTuyORR8p1D/A+bKnMKeGfocu+HWdx26T
AQVvlhtBaSUEgjULWH4gysDmvewjFJo+5cLqSoA0iEu9PbvpBhOnUgf/w5YU30p0RyqMfib+QSq+
DH9Z1Zi5spEXlGkDRgaUrEOwS6QYbeQ0QyXWlkZ6jemCpNqI82uGMfWEKUYMsLFPJB1Ey1hDWg21
rQ6A37sqt9BPPajwJTTiDW9a209UVcBOSKHfgSh/npRUakC8roGaDhsTdbTaLK+IPnaZC55bkCgh
fHX+FJG0cKfOGrbobVYyL3QyHQBhUNsBO/vCemuoJp4GWDehBN3oHS6y8JjFWxqYK+kAqAIxpW/i
SQAww9IMSpFOJSqkA6QNJDtAigI39ou99VRcS+8BlUC+ip1EBWDpncoaK6OKYsz7Ya/ea/RpUYxT
GCfyWmDSIZBqRfgVIkkVkNyDGVquwiX3Ley7vnazKEpviojY16Lp+UFElgjCsIquRTxoATGzHkWL
xkpDP20H9EUzC3ThVPZia0RnrSiF3QLMn87QX+B/z52C93HB9A6S1pWFaoGYXJEVQTZ9E0bhEvEN
QzQ083OTbLj9mjecml18prQpcioTmO3YEFT5i6HUPtuSBJx/+yKnAb+KaQF4NUNplslomxmN6nUk
xz3q1JEh7tOo22BR2DIxu+Ppe6KUONgRTOR5ii8cikfaxv/+zTL3qNEUAn/pXIE+tyFr3e6zBlpS
jl49FY32PQqzHdQFNnL3OaP8tFsnZhYFgS7OpNU6MAP59Cq7LzGeIOLbhLsZD4z+S27tL+ecK5EP
y8KSMNVqge934QJ5jephzhoQ3ivhl2V7n0x20I7mFW1D387Vxm2yag5EF/Nw69xdW5hLJqu2OoL8
PUS1lUxZwGoLoxDg9TLEbbUll7QSa030oP9rbeEXGMEYtUTBmtTup6FxKf1o0tuW7QQ6NMVWMFr7
dBjUwAghTjCYnhYeYqag4BTDLOti/TLtgNv7cfidJS98CP26+xjNrRb72maCDAIAJw4kHEpU5y5p
GiPq5lFaA22H2cgyrNwpM0e3SxNPCVt5ndX9uOwtKwED1QHksBiOn/OhxefLxVjycuZpKEtAxUbr
PorYniI7di/bWVsZ0kMD73bwIH+iGHKUsmOcNWBrm6CfrkEw6mKERkgkh1tzn+um0EtD9AUpxBJT
a4RgN5gyAKhs+V7qOuBorwq4vio8qK167ZqDWBgi+z9TS1itFafIowhQ6hjjovJusGqfTpZn4/Rl
zve88dst+pW11BUf7B+TCxeJuwJMNiNM2pDYq6tXjrxNH/PA1NIHoFDdch6xRbdrlrrQ9xnn3hDS
DYzRSjIww6bAq8+RdKCldO6maFX2MpmwwxnkUmPQV3NN3raafnQAmb7sN1um5oBwchFkWk8NbeYG
qsf64NTM15C4tmOKsb2NK2cttACSj2ELKLHhiy5OgjEqLh0F+GnSF0EInQKfauWzNg5BYueBk2nB
OJYbV9DaNXdqcxHO7CixRJ/AZgZl+0IaqBA+X96/tfNtg3PARB0S6IrlYQiB6zMbBdxixUIwLmbg
tAfgztkg0F3du3+sLM9BgVG0fhqAS546jmKF9han/G6G72o2hI8ic99HW2Joa0fvZGHLGn/ZVsSa
UgCuLfHFyh6c8Dcdj3ETTNmDyJ+t/tflfVz1w5MVLm7xpI2pHs/mRHjrjCAsCyb5tknWv+oPJ1aM
c2+PGbqJxryP0kbnYkhQUE+FsXF61+Lj6c7NP+LkSJXo+5CBwwgmrl06Hkj3Ic1HFv+0WPAXmzZz
1wEs5yDuL5bTJV1rkxKb1qMpkOitb8QH6Cbx8O2ynVX3O7GzWFHS8A7NaKzImN2tS386le4NJNml
Gf/KQvOqStO/iRYnJhfRwi4GlkwTTOYtCqOhL8RTo8CfiRYi+yn6rSb3qvthVBmjdgBqoKt1/s1U
1DgZtefgFGlu1t9VQKL18SNLt1oGq84BKMQ80gfysuWxmsJeUT2HoSb7wvJbLdthXtkreFCjnvQX
X+3E1OJIFSjJ2aMBU0q70VPq0rwLsuwqQm0kTW/YVl959WydmFs4oxEbQudy3kK93qUivI6GLT3x
z5oUYJpAweG/u7dwxDzmeWx28+6pb4X1pCApLkbXUVct6P2nHcb1QG6YVYc2OUAazrPi14E/We2D
AmVbo71c3t/VVOH01yx8FHhRkMSb+DVQxurkNbp5rg3EaN9EbmVdc6RgVMfg8bUogk0ujD8dn+Wz
BxAQ6AaCDwPzi4s8RbMgEuU0CtwHDv2agsac1sOd1iE3Iele8dKdCumP8lvBMwxfh1uqhev2UZQB
7wfyFADbz09Mj57oEGuY9OiIdTSMHgpmmVt0r7rVu2ZugG8SY795+N205Lupb0SHtf4fMLIY8Ucf
fyatW6y+NLoeKFKsvh++DIXlh1T6ypmp0Ou3kNMjyrxBNaZwjTGIWPqO6m0QWu2NzDelSdZCx+lP
WRwzAGohMtNiIwqOIXcR6PwXXmZ6HR023G1e0/KLnxpa7HiLAfZ5HAupmo30N30zHIgHVG5Tvlh9
By3HfY3qS4K2gdjqIa1VW2axk3lAFdMZYKo8/9iAFaR9zbHdkVG6RgXIyIehP+YkSCAEkSb3Qt3l
f4HBPLM5X0on1+hk4mR1NWzWKOTXAY2VkflWkg8AjsTjV4xUDE+Xd3jtmjtd5ZwSnVgUU1zlPYFF
EFcm2nVagZChdMXoGfptkm1Vqufo8Plz/mdPMSxxbi0ktUpohc9pF+VVXDaHCpB2m/+6vKa1++af
NX3GMkwS4OV5TWrsvDKskY1AIC9+zjmWOW01NVdDImTYMMiGApbDlwCbjBKr7CCH5DEBAZ7J0/VH
ZmZuZb841g9gdrNSubH5Xob3XbFxPtbP4X9NL9E2zaix1FEw3dbjbqC7vOv8HAJh8V9QKsyiUn+w
TIg+n7obthwxMEVhKS/fRLiTyqPRLdUHlxhXWeLbkzdtyiOvHv4Tm4vTYE9TVpASNi2UDlJ7l+mo
D6PWn+w0dm2BnjQMLM2PyffL7rM2FHG21sWZiHtH6zICu0Xee5IfZXvHLAR3yD3eANGpa62Pqp4o
dx11Q2vrjKx+UwDKgWmaRZ+MxQ1L0AkE8hD4+KyUr92QPMbD4A3iLdO2uKVWT+OJpfmXnJz9duwz
sFvDUhlmfiWEb2BMuNKK4PJ+ri0I9WN4jwH4KVhsz82UpB8B3MGsYqZh/MFOEgz2RYijhWl+S0m3
8fxdtQbkJrQg8Gcu23BOLXOi6RgV0igG/UMDCFHh5Vr9CH5I7/LC1vYPs4P/NbXwT6OiGYh+YEpo
GElOjRbNZ4x7+5XF9pct/SmwLgPnqanFHtqsEH2fw1RZXDf0G+UPVnXX1Tei+plCT3X6ppM3Eh5o
/6VMn0BDxbcEXddi6skP+KNVduIraMJaDVrKSH3Kjzy/0p2bWWLSoQ95vNV9WruSTk0t8py+Ds2G
AyHvNZP9OxVvaRG7pdX7lQbHASK1N7ON7V39kChUAh4J7Ncn9nUtsbS06UN8yIIdgS5+7Srh1/1f
THIAafuPmUXWZDgCPTQTZpBFXreluZtgIh7ZAdi+DUGwlT3EXDW4EC0AoTEXudhDSLT+3+ey+dAE
WWhyf9BzKGFE9kOCqprP5IhRtr6RG/nEyosIZG4YE3TQoUVRcd7qUz8BR77Ic1F6rIy1J6PLbS8H
89PGB5vdfXEc0DREJ3bWxQOp1OI4TLURlrmBhzHoQ6zO12OwhYBR6JuDCkcGQSAiN+at6dq6wMyP
yj1kKyF7ulhXXfaoGNYz7A1TBQZGoLOuB1kutOk6BlYCdoAuRBBT002ZdjTAO2jbUcDaeN9OiSuj
AZWrwQ+tIZgs+0Uvies4GSqpKTiYUr8quJfS1L8cNFYiIYNgGoLgTCiDisn5p1AjJKjGCqDGommg
54lsJHGz5CNvHy/bWfM1htFX/GHW5ZNMod0XGqpY6MeP7Z5BdTIUxwgIRBDnmO3Bxjn+/5lbRN2S
yEm3p9lc9Fpy4RJ+l/T3Inwtht7dpPdfewaA2hqwQMjdAju+HLDNqzoeG93CGPPgZ9CZ462bpMRv
KKC+bsOOU3lbbo1lrn25mb4boA6EpE9dxIh2bBTZgGEH6bdG5hXZr0K9DPrWnNxKUP9DE/4fO4uA
BMJfdBcIjhFzDj0IgCyXaaZLJi+rNtGP80tteWQRWWcRDYPiBbD0xmiU0oxhyyYPo/mgjaBi610Q
5HVtD2r5HQbuy2oH2iUw2u6drVLr6me0gVqbB13nNua8FSdxKbfsxMrV+MdJW/1nWn+z2Y72oLeE
dBR4Dbp9Nm6ci7WQcWpy4aiiDceisfAVrUZ608Sfc0PbiLarH/BkVYs4KCxDDayHCa0WNzUDWSPY
SHsZ37I0+9Jvck+uFUBwxP+7i39IAk92kVpZUzktdtGuhw8p7m2olWQiukcN7KoyumctcnYchcrW
fG/+CuZ0Zn1xqfGSt6riWK1ojmkd1MkIJOOT1n2E0ZsjbsrqmTiBNF4qcyOnXHsRnFleHJRYo7RQ
DixDq8LXJDh8WnHDrOReWuVrU2U7NTxh8G2vRb2fJs/KeCP9Fnve5uYvaiGpYalyqLD5af2RhY9A
NPot9/Lkvv8jyVBMeIt9aba0fldjETiMIXECYDxZXrVKRfpYmLAqiF+0z3bzEA67pNhw5LU7BAS3
/7GyZAGdwY2lxmCFmbjTO9yuu4kcKPtGG1cOL5dvkJXsAUUBHePBGMmEAM7i1MS2KjD0j1DEHQze
pHurelNce5Z64WL8Choe1M2Y2OiQbBhdPtVNTBz976R7X/pl/8rC6wQPSsFQL72xo9i1io3rfw6o
i4A7w/Ew1gDKD2SCi9MChjkeAYCHHIk8ViCZovKo+q0W/Ip3nBlZHAyWW3nYGjAyjQ8tXukZB0UD
cjC2celvLWbh+7HmECAKZjvODyEH1MJD1/n3IkwAMALgN79R/0xTnt8RRQ0FTahZwAkzz8ze0I9z
pkAxEI1WWx9ndd8wuITrHcWUT4QWnAJVXeowVYX3U/+rHp7t6Jm1//4VgAX9Y2W+oU7C9ZSio5Rp
sKLZKJRmbu0EVhjU3dfIqNHC33C4tTsWZM4EY/0W7gh9ea7Q6Y4aOpuz83sZ/RiMGjrVbxZ7tKcD
GYKhAw3Bhl+sXIAo0No2huOBp0HF5HyFAB07ZjYngxlrIeMKNhs7KAF2dm5qM95Y39oJthEFAbBF
SgYo4bkt6LeWNHRm3CkEiMv0yMmrKN+dcXRZ+3MyAokIfDlQrXkJ3AO0VUiYAN9ZBCpVW1mUDLDI
AFjU2tDTTHA0TKFPMaL0/zK1fN+j55CyOp1NaYOXjulBo18MjOVPpbPVx1hfFZ5QHBr16AkuUrEm
omE1Rqz0VCuzjwLT4j+cimjvQGpXz41NQ+gsl1l0DRB+dpNNk31jKQqhBkK4OEIRHu87ak4lAUl5
TjqIQIu693Uj7zfyt5U7CfAGSvgM9UW7abH7FRvHBuMRwDSjHYviqtU8sLJ3M4yGGaUA4dvXy59g
zZdn7S1MwiLnN/kilkZWV/VVA3uird20BOvL1xHpuKU/OPFfjKwAMYX5EWjcgHV02dzQTFl2xry2
qZbky0iFCqhd3UoQ1voAp91BUCE+YPEbmI61Z7QN3oyZmQNPxU/nVWQGxkMTIIuZtMI3p9DVE6Ac
5HmKR0o8o8/ar4NlpAdq5ux3zTr+HdOrfdD0nZG4I3o+R7No2DtOfKRcq82dJydJWbrXSnMYfKvu
hQhkb6VfmNBAX28ZjQ8eHfI7mgzUOwiJyNbDZuVmgv4L6sXoR6ImsdQz6yMBuXr1P6SdR2/cSrOG
fxEB5rDlcJJysCXZG8KWbeac+evvQwP38wxFDGGfszgbAa7pwO7qqjdgJY1a7F3mZTdxqgCGMf7+
oENtBPAlfT80guagd0iLJjrTUU4t3I7heIjyM7VvK/qudCvbfuGY4zTl/DYmwQr5A80wTf1MDSY+
XGFDaM0H3Nmqq7KniNrvk8w/sh6XN/5SZktIKHHQ7eGxzwFFplCWeYGXI6TTX2K056S1pSaw42TT
9tEusr5k2YunvITpiqjAEkf7NPAcY9TnTSTWCoFVtCULIPWV4ITWg+Z+k+PWLjoIN1dWsUcuNrCw
MX4ojbfA+zJmd9Uat2Cpu3v2U2a3S19jjNPo/BRBKDcaMludRH87cTTxW2hUG6U8yMmNNzoQxT0E
S8DGpv+gN4lcNmaaQP5Bdc0p1Ybiwr5SAEi7CGWE2r3v67aYrZxyS1kCtyifDDTWSWpzdqzKRi0n
rj4hvSmSdbtY/uYme3PayOUuHK5K/Id0Y1VWeuoszrLhSQISL0poZOBSp8/4JBVyc35KF02I6eyL
rN7KVuxo+mMuP8py7/j9VaVuAQ5c3tcLF8hZzOkiPImpGsidqya4TQHOzRjD+B++TZ0CLY6hkAHh
B3RzOeLiLjod5uxu7YfO6w11ClluxWyXqftk3E9ICck45FJtB/nR8m6pBtcFPiKPufVy+QcsD3kS
WWAH8WSeLS4PjDxuY6iQonibZ05VP5k13fNxC2Ik5ci+HG3pXc4M/y/c/FEVBUWUuxKrGor+RpEP
mXU3tMem2AgJzsAQ+lz9JRcPNJwT/Udfqmvxl3fVn/izjzZDdwHiOsP1xiO2QmrwmsOxEzdD8NlX
Dj2uzF64EnPpvjkd8ixL6ALuBnmaYVl+9Nuf4ninNr8uT+vSDXAaYpZU520bj73IrPqw8zNQVKK0
0wBBWMkBH61yWtmVG2Ah9cGSGHI0JCCUHOcIMaGTrG5UAMWP1hXcRbE1bav8Hrh7Y3XNlkJRW0Wh
CJCx8sGBzCoT1R28Lt/0wtcsdbQRLFW0VWDL9eMa8G0h04W+PqlZw9tBgWO2PdRaM9Ga7qFNJPTl
0xve49swfG+Lw+UFWzpTURqnfsLZxuNknoRIrai7yBZwjzUaBsipoUIVU2MVtfqqxgJtqERulN4S
0xtdMOHsJmHTxU7h9clKo2Rxek9+yXRAnJx56O2qYquIGJX7/WM1vmfBWw0yYIjojY5rl+bi/Foo
iKHDpiJqP5tfU1O8EtkGkEEjFiuuIagOOtRvmWW8CTGAocuzvBCNtAjlDyh5yALNpa3EACEbMwsL
JCGTVzOv24McmCV86Dx6bN2hPF4Ot/Chg4Q3oABymGofnJ98rw3MwoK3IYajaTdFBJpLkjFrrNU1
9cmlkdGsw2NeQwYB69DzRQtwX7UwFio2kpLv/TLdpm177APjUDfVSso1lRxm9zCQBsgGvNrxyZu3
U5quo+lYEcoM60Ni9HvfWJPmW5o4KCE0PvnwpA9KLa4viIWu4FMb1jyTMTb5gbcVViqj8fPyCi19
dihG4HvKgQJ1YZ7KFBTd8rzsCrAvIJ/F5hpAxdZq3WMuGnuxLu8iucBfM99JrvljJfa0t+cTaSA1
S+KPyTF1l/M1o2vThL4xFhvZHba1O26zOkZwrN3pRXnb6T73fGUnAkJnibZPBz9cqYYsfOjTIlK8
Ag6Kit/spi+btIZaLxabvNPhhfQD0gFde0ebx9+qoZDYotFI28uDXlrZk5jz6x6ZDDZlKxVcTNgr
GV9FHkNpjFD05TBLn8OkcitPah2wi2ZnWAKFTzBceWJMWXux698LSTtoY3nQFWl3OdTS0wenGi4j
k/OLTGb+6ZVWrI4a5biskzcpcEq1VR0PdCfUficSgbY2hZO0LxFZRdt6+/8YfjZUswct5hWEr5re
2KJIDaEj6HZdroItCYRhw2F+33vCYBeh993QwhvXLL+v/IiFLApeoYKtJOgIKvOzYxwy4whMQSs2
cD4edByoqa30O8stvkmDfBW6yr4BvN34lmdzfKwk6UuLDZFgEkABwwe79vw7Ss1yMEvLKDa8i267
qn9CL/VJ8MS3YrS+XB7o0vY9CfX7ODm5G4chN8GymISqczjVQ5rch63ub/RSXavFLh2zJm1OAADM
K9pn56OSh9pUwPdzeVAQ5Un3pVO198uj+V0ImJ9AFngIA8jqZOs7W7YEZcNxiOR88lQrVEcsrsfh
RxMd4lix0+rNr/Vr3fs85Ee3fy6kH6GVb4r4Vsh3yXgw0r06AMbc5t4ef61OWbk8P64qxt486SiZ
mKiPz2Ugq17z1KyF8S3BnsOfq0m8zSC/h9bT5UlYjIMnJS7wk+jk3Halt1qlpSeIpg+e7BpNibCj
eYWa3qrNwGIkhgSX7LcD8Oy894W8dLsApz9469gYPqHSM7j3ffLt8oA+bhyoQr8r3BPwAAGg841j
9bhomi51prqLdUyha7QsXHeNyr40GL4Eium/RW3n+WrVCFpV+rww2ryPr0lLhduslOH4gnP0hq5a
6YN8/PCmKi4tNkiiU3V1tlMlF/2S0aXkUBou+VOz1xpjo2drSlJLc4eK9qT7qcBLndOW0U1Rojjl
8d0bh8T9Icdvl9dmOozPPziGAbGcscDWIbs9XxusT9tBTyAqJxoSjbabIAThXyNrZofqUW1+Xo62
PJo/0aa/n5xWkuQGShwRLei07Sgi3hobzuUQ09n6YUDIW1iSqtFXmX+lhaUM3pjxPhIb5U6Iza2U
fbH6J0N+kccG+ZKGJ2CxpqN2OegHDLoSm4Wu1TwAO+FQNTtf2w/IDPXJPtABo1B2zNdYQgvbb7LI
5W5DMZp6+/SLTmbS7P3QanuF2lNVYLewE0bRiVZdpxaiAPaCHqKrE2vBmm1yt++ywWtIe2MtcfSs
h8wrUJcIN/IQvg6h/qnNXjQhdiL3EYbLOx7315BFSktxCnS4Li+sJH9c2bMfM/39ZMhVR1XcnXJw
y3oU8IrLazSPAyfiCrRr8zVtsusWCIc1Ctu4u+37YeUYW5gMHoTUk7n8YArOmTpyj/RymPUFsoHm
J95tHsL6bbWJqngtg/uYB8sqvU7auAhnI889m/Ysl4KAtly5yQbM8VpcU+18FB8Kw3vX9OY+KiJj
BUmw8GECsUQ5AIgz/Zt5K0CrMdWUy7pkA483INeu67TYXl6/helDnwCwNjwrvsv5w6YLtMAMZRmV
w+xTPjzF6X74e1zJJLfIV4FkEcqs829/1MyocCOt3CBG4PQImCCwizSy9/f+ssShCz5h3NCcnM9W
0MSt18XEKVATR83cVQ5FcDSF3eUZW7jRpmegzvUySQnOuyZlyoMUmmO58YQbPX2Si8OIVeIa32Np
Xfiy8UUUSbpQzD3/rCwU9PrCUEu+7QaCn3loamsXdOpfVzqYM7byBJaDHmrMLprIUxM6gsxZMmKv
8Wi4hQ2P16RG9g+TdhJndsUMCbrcmU8cN1F2/uRCYOifkQhL7WxYqTssnPpnQ5pm9uRACiJNCc2G
UAOyAjpWtZ1mOVmBYrbUvpT6e1xicr0mcLRQnz6fyGnXnEQV6lQZ25KoI6gf1PYs+ecgIVjGQZTZ
hnpEMY9Hcl3LIOmPCJVdnt6FgwLgACZwgDyn9trsaCqtqkzD1C3pp4QbcDogpP9+ASFiGvQjuXOk
D4bHCXUNvZ8aVinGKAOwOONLGD8H40qesDQQUh74MIrJY3muDdHKUZNnaVBtgqKGCLTpSOMuT9XC
h0Xi9ifC7B2MP8SIGCARcuuoVbEtVIDd/mUUHKkcRZPDqTjbDIWSKx1KqdUmbjEbps0lrdlqLtxF
nNd/IsyOB6FvxL7IidBZD0G8FVJU8UAru3aqrDSaliLBfKFAifw7CLppxU42ttL3bGtENjdDcl3W
1J9IIn5kgVO7h8sLsxZotjB1k/hBmRHIYod1EnaaPGfpK4FSWGt/LpBsYFnLBiUIdbr7tFksGviI
EndFhd9eh5HbW5Hd6QJqhe/a4KDxXHfvqvo+Vne81hWttIGAN+bKPlza6Sc/QZ9KJSfzWiRlIw4D
P2EEZ97qj2q2Up9fuKfQTKC3r5M6TGjo8wCCmKURZtHVppZkuyNtKV1blkobNv7lhVs4cE8DzVvr
pjBUTWQyEnEA8o2a/bUaXE2vY17GmrpT/JVyxFo8+XxgWSZIracTrwkPae6UKinYLtE2kmDnyS9j
bbMsHRgn8zi/Ik0NvJRWM48jFg8ipPPvXv1weQbXQkx/P9kLVa1UKrbrLBVq3P1LIt3Fa8iL5d0w
Abqpbkm8wc5DdEUYBWnAKCasQXHTeFtf2fdrZkSLm1qlDwZRByjV3EyBDpQhjA0D6UMR5HRiW2uN
2IUIaIWhYUFWDHJljl6LotKNC3koNjoJuA1Ix0FKvFrJiqbPf/ZapbUG2RY9Hy69+ZtCNaKxDi21
wMaudAR9X0ZvtBVGXBHz5t5fQ4guDYmqEo8Kk+7CB1xREav6WPpU8PRYHJ/1uvg8+Fb594URyjB/
gsxOPKgXKZZUFD+7oLRxT7iqdZULQz9c3skLMzdBLqSpIzO1SmaHThG6UphiM72B6ObvitYAbIMj
oZ2m2X1RWuaTqxbFpyAutJXAC4cCRTn8b3ic8ULTZp9Q3fpuYwK52ATi0TO3jfVQ6nspvC2ir1WN
Isjj5XEuXFZn4WY3vOoxfEOdaHaDvm3EbSTk27AoyfYcfENWtuPCBsG1AzKaDvyVwsJsbJ5q5U1i
teSWxbFNok0MquTycBZOh7MIs+EYcazhUtYznBwASRptqvBJTW6zqncuB1qat9OhTH8/Oen8DgFU
7M9JVMXHqsvs1MNgvriWMhSZQXteDrY2qtmez3WMejOxKzfNKBT3iR/120YovMd8tB7FtJZXxrZw
ivOBTV0kDM+mE/B8bANmc/mgEa61HtPkWAY/rHZlJyxN3yS4p9IuRoRgDuZsi6hPBnksNxX+tprd
NYcuAmv03P49SwOGxkmg2Vhc2QXUGRHIDA/Yw4Tig9E6auMM/pPfriQqS9v7Tywy5vN5M5s2BIhI
rLp/Dror8x9KHDSckJHi1pvYfbN8YfD8vtcbhaPBK+lVvoZw4EVhpVSz0N6DY4LDDp8otZoPUmld
7RcjKTufkOe4vRNXiePpdiW+yPVbHW/N/gYU1mj9urzFl/bcSdR57pWgYSZX09jM7Ecea69yKW/N
Kn37b1Fmz8sui6086RgbaeQ+giKRxNmVYq7pIS5dHtCJp0YTbSa67ecbwbVSxIVUBmOIv7L40CVP
YxbZbWmPHRP5/fKYfucis0se2OufaLMzT/ZVvMoCotEe1r8OTaRdR0aM00WiuSM4fEVBhHwsH2rJ
0zZaWmU3BtDNIwCAaisKcbDBrrw6+mGiO11Zm9s6yn9c/omLiwts8nc5eXKiOZ8PJYjVurN0fmHy
0EV3MXRi8ekfQiBvhL+HRpFpHqI1Y8+MEiZBGzEmbiP491VuJ667kn78zsvmsz3JuGH+SX5Ade58
LEGmpEOiD9xhkbxt69eG90Hjy04YWruueJcNyy7aZtPnQFPE9rZWBtXuinFXNV9G8yH2y6MgqVcU
H+410XVya80FdukQOv19yvnv63xDLtwQ3m0WvdbqbbIG3Fra26f//hT/5OLL1FCNVJVDTuYQUpLj
WLeO4V+F4YPbArdbqYEt7ZzTaLMvCUMGIZTBMUDR+jqUU3HgRVsDgC7drqcxZt+P3phjV+TMGCpv
YfRJ4aUXOfKwskEXkDcyjVDg6ZP8JA3o2cJ4KO33ScxQRvml8wx4mccSeGtmHNHe0KsrlZposfYg
WxrbadDZalWWUpiuxm7t2s9x9EmLeS3d/gNvj6GRsk460qT9c1BbYDRtgmg/UfJoGxQJPLf2ZUz/
3gjzPMzs/jMT0xWjgoXCSmrMHGvABGYc0dkabBwpbVVZuc+Xl+xkXLMlgzVbdeLvnTHUuEOCdAFN
wqvgJlFCp5usR2JkvzOg0laxphextPNP53S2crIPsl0RmVNXfAyaL1GzL/ury2fmUhJ2GmL2cQmy
kY1iJJFP9PFTa8r2gHt9ZZSfSvgSdAZWCnBLJxPQ56nbh8DHBxxdMQpaULmE02Ph5xB231MsSi6P
aHHSFN5rCGzA/p1jGzrPbXFZ4X4PCvM1QE1PyvRb09dWwiwVyaHu/Ykz24kSJL6ijInjJ8Hnqvgc
NNZRH2IkFoaNMrz2o7CX2+a5Crqt100GgcHGHOLPlwe79FI8/RGz3akaiRR04nTlDcp94/o4W1Xb
MFZvBN27okmy1fCzyAh/OezaHM82ZhvJGorfhI1KxabiY+cSMCz9eDnK2uBme1MJshqEJ1HKeGMy
jP6zgk+7AoDkWxxdu7SBL8dbPChPVnR2CYiZHhW+McVTt77rAHFKrVeoXv8QBcoVW3OSmplbMKex
L+KZzqsxVW7Efq95TtfcKtJKlruYwsMvBWdJW4+q6SzfCjwDTuI0mCB7KVXZDq7KX4buGPI9QgdG
7PTtt2HNRXbxMDmJOeUNJ3mBV1eKMeTExKcpCn/1WmN3w6sV3tWrOodLKQhuz6CM4RyCxZgND2lv
g3IwX59m3pbpbePflup9nb8o4yNIxL9fsdNYs2E1sjAOTUYsNfZtX9/mrqPiyCV0K/t9bUzT93Ay
fYgsBZmOKdXGb+Jt1puYLP0IdBnZghqevbIhS9n+p5HNkamYpTRF6U2zmN9n3k+j/Ryg+2OJKxO4
tC+mvj84MGT1uUzPB4bdrtgJBv1EzUDnM77Tu6sRBVa3vpbz/eURLZ1Mp6Fma9WrcZ81OqFwiHKz
b6Jx1Lyf/y3EbJnSDJQpr2cyHQk1mOBByN+L/u/BvBMo439TNn8LW5UaJa407bmgUbehiEKsVOEP
ENC6vJcsV9xcHtTi3gNoQOUMMi8VjPMl0uvcBMk2Pc96+WWE67oZ9d4pu+FajFOIGMorHM+VmEvn
LeocpIu04qYK+3lMS/Ulr+xo9CYZOnTTiV7j7eDE6vPlsS3HAb6v0PsDizYbm4f2kgpBotxYaXfE
rD3Ex9MSvE0+rGy+6R+avwsBb5IBQ9SZ0GHnAwLREFbVyCQW7bcqByCoQLne99EWQSQl3UprZr2L
39VJvNmFleSp18k98eTxkHW2Ijte/cWQbtP8r9HGdCckBB8m61oDv5nzgcmJIMV1EFabTCI53Hb1
rYspmHz823UiCroBMqkh1eE5JilRI00exhjf8xAS2g0o3LJ3hLWn3sdJA/dESX8yt6esP7f5kFUr
hH+v0s8uHeyMMf5KclQxH/I1HuXHo+g80Gx1OtPzQcQo9I+Ud6TKE97I1ffLM7YUApi0SoWW+uYH
3qJkArUXWrNiS99U0i+9fc/W9HtWQszZtb3VRLU8EkIejqF2VMQ9TruXRzFli+efzbQQE4qeYgqI
7GnFTu69XCgGsZZMSmUBNh01rXkvWynZLI3iNMTsWvCUUOxHEPOAzxDPyr0D0izbokn/+jXFSBRR
pDCEAIb0AeqqxHWd1ZxoWad9i/yE5Biy0C1goaeuq81dqskrO+DjkUNEVQH0TCNRhUp3PnfqgKY4
ypPkDAANYu9utPR928LuOvq+Ytelnax1iz6epmcRlVmF2y2QE2/a6YaF3Z4V274IvuLAeDPq7RrB
6+OlRChUAJHboHBIkf58cHJjRoE7XUqIt1xHXv2kJxT1hEL/1HfuUyO2TqYPny9vxgVy/XnQ2Vap
xAItVpHbwvDGhzZHniEx381w3FjG18EwsK0MdkNpxoC9hEc9q+4wUNmLxmcxdh1Lba9Szdjlkbfy
aljcwCdTMVvnAhiR6yb8Kqked25T3vVAgTO/WBn94oxzNlJKVriV55Q61Qyaxuz5TpL+q16rtoqR
A/6biHmM/aEyBPvyZC+dxTxSpvI4DPcPkte1iChiaDKqOPlSK+nOlIrHZPyVtso1zPeVdGNxbCfB
5PPdVFi6Z9DEpZpSYWKTRoeoOooWpinXVX2UzDWtksUVOwmnnIcrvTLQypKpHF3X7lq8czRx0wdr
vZq1Uc2e4o2gi0Lr8o30tWULyjc/cATxmxS+tua1Ify4vF6L3/7JmKYxn5zULQb1VkB1CN6IbPeB
7BT1D69PjzH1vv8WaXZ5VkJaBuKUSunpryyi1SnbUfUpNf8eEMPXzskCOBUmDK5c5yOCHKkaoWSR
simqTe32ru5j26+iw+XhLF5xJ2FmqwSxk6wq52LI60h03CyQDmgeKNvLUZb3wp/BzJYnDVSxMhsG
o1c3EPd2ivHWdse83uvCpjC/XA62vBcQrAc0hGOzOMvetT4dLVdgf6OvvBEashu9spXCsP3072WB
WSS0q8yp4TLlhueLVOi9pLg6sycHqNLqT0rxavQCIk9PUSptpHxl7y2dSrz3YTbCuQFWN59GZaSr
55PtpqVmR+VdiVVHlj8O7Vu5JtG4NIkgohUofNCKPri4p2ozmGFKypt5kDXb0pPvZTkM9mmuPSCi
VX+6vGZL23BqSCJihe4/+PXziZxgM2pSe5MuS7hNZO9u8Prd5RALkweeicEAIcZqa75WmeaV5hgC
SbWEx6C9DRU0PHJHp3phBivbfaHGNXHMeTTAHaFXPX9vlRk3WZazUH6I/ur4buWCg/+inQfDLqCK
YSgoFovdQA1sfEq1NYAYbxPma5a5Qr2EngVrAyXhedMjzMxk0KII6KVMs18LQ/+L4Q3RVqo7ccR1
Loo+pa7QbUXFy45CoCTvdWbqmxYd6Oc2N/1Pbk0S4Q10YaNUqHdmGGg8fUzhplPK9q6ppQ6KgZax
I3IlKt6h8FdvUdwrG62S8jcw/aa/6aVcQPsm67+LgqA9VYVp3JWx5aJImfgH4IX9z6DRE+Wud1U0
jo0pT4tHUf+l93VWOUrsy8d87IVt543xcRR9I0GhM0LqUY388EbLqUnZ9K000dbaWh6coR90A9SB
mnZ2pGeWvEcXXYXZNSaqvw2lHGPXSjQqYLad321jfGa2huu2v9qmtyrbN0I/2FhhYykbF5OU4yAp
/XUoCclNFSfdJzMa85dKKD7D334gVHvos9QAqC2OY2vXhoU2pC8nk9eUrOyCtou/NkZtbkYpj58a
it0Hr7IkaAwyupFpT/kfQEFQ5ltVj7oW6K+o71UtVrZ6KIZHKU7lbSzxqtWxnLzioxHQESiro1C2
xZXWtuZxAIbRUrfq/W3dCk39HrmN5F2h4BeD00xyE+t6Pci2hVoaylXn9zIMBKbc5ktA/K5JRQg9
cYlJCZ3g/Fktg5DkNeKixlT9JclLNHUEy9r1rQtEoDD0xjbVSvzaDyGKQg1GHLqjWh7IQCl0wx0c
cJibRd56z81Y1eZzHPfNsGmh17ymXZ0cchX97I0+JtEONabhh2h4AGtKSP/bRIjaz1gOWbIjpa6e
7cdCJaZcav4rtomFeaV6hfWJzDs5DMgoyK6dFK5yO6IiZtmoiUHeSKWmvunl3EivaOWoKm4+srhN
C9HP7Myi1WgrKR7xdpZaBhTWIM/5ELus3TVpqr4EiRe5WGql6ZWQiOKhYLp2Nbn2jzLOVR5MkWyk
duS5n7RWkZwWRZfbRqn7HU1t+ary0+LgCrV1o3RxIBPVi7DxEGvvUMdd+IQQ83gEr07Be+wDaZu5
aJmr/ejZZW61aFBpWuc5eWy0R0zk8QXog15yilGRfilBi+pN1QbkUK3cu7bu9e6NIgjxs2hk3U9r
bILtYI3R49Bl9QEctvQTtba8s/vQHK+jNHSdxNOUx6KShE2QoCdhK4x2pxVtBIBU8MqvSFcHsm0k
ufdFDkMqoXmQm92Dm6bJFVhQgeqoWMePaldZz7VceA8JSIMv3VANxk6MFGs/drKbHkZDqG58KTa4
5bXA2yZ1pD+2eYzldWcKsXRTi3H+pMHjuJYFPfyVaWSIdjdaFJFVteq2ppc2lq1HZts9110ab8Kw
qK/00RgcLUnCbQRXaFg7rRfuOmyg0F6YpNKwS56lWp1lJJpZJZwKfBGOMCJq3SebwbAcoByYBoWf
teKnilup7XNuNnZ09X3wMifNbjWx/375llpg+vE+P/kxs4SsEsW88qLp4o09xAs+JWnihMbXvlec
sfF+ZcV74Wk3vkvOWaM/Va09bRfvrtMfMEsyYmzZzbSfil1deBWmjdMUqZNWMmBTFTMj6aCq9VaP
fSehGYBQz+vKBCxdXYyfOsWkXoyW4nkqIAhFCE6Fq0svv0e+6viVv1PS6msTv2bYq9hlm21rPfOc
OPdtK+9XMpHFzUC5wiDv5fE3r8IBOsOKywBcDUT4XnOb73wqV216ldLvWBnpVJCYX9JAsP4Xavop
J4+WTMDvoG5Aiwt54QTWVgyLbQYVB7fYoX3Rg33vXzXySsK/kIrDmZ2e0Gjv4Pkwm95IjFWXYjA5
JDegNnYvWOUdxlFEISo1NnkZPQlr5NGlzAtiC9IqkLgRw5sld74nCGPcEDKogk2HIbMn+8jyHd14
U6/5qiwkkhKuUdQeJZ4uylyXvk39Ss2VgcxLea+9zjbWWEdL++M0wDS/J4vGMSgXmUmApi4C2Ilq
cpd27luM2T1PwrhwLm+S6Wub7xEFph3Skb/r27PlAtPB5Q1sbJO2z2X34oevnr5SG1ycsj8h5hwZ
fxCGXOgI0Su9o/eVU5X7/zSIeXafuqPa6TIRmvK72R4a4/M/dDhwk5jsOegG0OSY674o4DeGKJJ4
QAQ+EB/MRLKisgVJekvl/Kb168fRx1+66Nb6YUvfkzLpjuEiCHdrTu2NlBjmtyhXm7aSkBD4LiZb
sjXBH7dV/KkXVwCwS7sPppuFYRjSZOzw892HmV1TKdNVFUmfimwbj98F45o85fJ6LUXB7kZCl4vv
lULDeZTG55UpKqxXmN5XUDzd3i4UrvS/xzUoAIb/xJl9S1pu1V0QiYwGBWgxMw7VGN9kpIxxKq40
ipY2OR7xJtnP9CXN24i9UGIG67NMXP83sTneoLRyuDxrS58qGo3cG9MbnVfs+awNrahyddO/ERrD
g2yWGk7RB+4mlWkb/UOoaatThEZnZ36Id1YZxbFhTUlCZQf9VZr+xLbqcozFGYOqPjnwQV7Xpr+f
HHSDFDeFFQoMp3+IRM125RUE2+J8nQSYzZfne0FbD2618eghw6ay1aKz4zVzggUJTz4WSKIAjPkf
jevzcehBUPhZpE9ENrE4VGlEuUarh8ER/FA4+llX34RjQSk0V7RE2nimGj6PhVh9zjo8VNxE6g+Z
Mqa3eYle/vbv5/j0t80+gHo0S7QF2TJl2oJZ7Y+Z0K18yws4wWn8eCxNskX07mc3SCGGgdKZSN5G
o8rTUHmWii+d7B8izPjylKZT8jPPxcdW81dS2aUNdBJ4bm4CENqsgoGJd0Np1xn+LpXWjMam3z6/
HU9DyOdrW4+ZL+W6BmswFV/qXD54brUfDX+TG6pnR4WH6LL+UOXql8vrtrR1T+POXgyxUuKpJjK0
RHgo4u+FcGXkny+HWDqDwaxOvrQYtuLLdT40zBN603BZNuhPBo9M7V4HMiK+XY6yuEYnUWYbsEFq
I8oGonTBDzM/Nmuol8V/n1uZo3dCVv5+bJwcIqOeclJmfOOt/CJ0N5G4srsXF0JHD5R+OaSmeZW8
BLxj9DJN4KbE307o7aF4bEdxpe66HMUwkJ/l2uX1cb4WXedzPnSMYqiesm5bDA9ltHKxL4agUMjV
QbKHavd5CE8y67buOG2L4Xf6cgdMHvGr6l921UmY2XqbY8K/azCSIjxqagQH4aDqL2Ky0tVe3Lwn
YWYTZsUi1YzEAzUzHJL8JjKOjYCRz+by5p1+7Iev/08Uddbw7awgHWOPKLKxGcMbsfyKopIlHc1+
K61JIy+OCEAf/+FlA4jmfH0Qo9R7pQrqTSjdBCNUlTA6huUPGIkrQOTFAgAefP8faT4qjUKRyaHN
qIZNk+9M/VrLX6Xh1U+PUZqRJh3r8DHBs9lbawwuzudJ5Nlp2lJq8Oo0gsjpgxN4SuobpXnpm7sk
vOmLv4fecS0hvDUJfgK9m3+5MdROPQUtCZT1vsQoWXwoO1vAhXvtjl38sqY8dlIioJww/f3kCCKp
CJPQZeUCNMorVbI763vrHy9vxcVz7iTItH1OgkR6WTdWyKIJmmtL/RM1o8sBpu9/vtenRhMaMuIE
g5u9oaO8TVDGZm1G3s714G9GL77Nemvj5dU+NcqVN+HSdj8NN9sKXq0Au8sJ14SuHaveril/Kw2u
YY7XhjVbHNEsazwtiWOZ3xL/CvLVEFOOPTTh7vL8Le2C0wHNFshqOq2rawJp9IbRQMv8vdytaYkv
KF4oyAlNFPCp4vwR21wlDWrQ0/Gabj0hozR/7cWvpXpEzbAJr0X/SVBt9NkC9SaUP0XpxvVXkuql
CT39BbMDXnThWHU1v6BO7uPhmcqmTXWdYpBthcE/XIt0GPiwIGNSc5llQYYYJaPZc/4Gw70s/CiS
nbJWzllattMQ03d38l0JZdXKwhRiyKTHNMSaV3d3NSJ6l3fHYtHzNM5sH0ZY3+RNSpza2lvxt0bY
QvH0sl+KBkkudfxhk1j3/Zoj98KByzZRZGzFkNf8YBAx4ihKQkBUqSxsSfreNkgMI0IoPfcuvcFm
5RtY+KjPws0+6jYL4phuFjUSr3wo0tRR63DXAgElg1qZ0IXz8CzUbGuMpGRmp0/pTJtsyzq68ip9
e3nN1kYz2xplKxjKUBOiTe5H6XWQns3xOf2HvIyBoORtYuDBUs3u/aJTLT0buab67pnmgBYc03pl
WZZeaKcx5sA1CSeqtM65oQYzdsD/OpaHJZMlfamNzJa9YlujAIWjD0Jrw+PlSVx6HZ/Fnt0rA3Yd
ltYRW1TfwnzbRVdxfsiCl7HYVv5nTzvUyvNQHLvcUcVHRV85QRZOq7Posx0ZKb6qFj2zm3jqxhd/
lPjPRr5nu5n4kuVr6ixr0eab0or9OJpyOHQrJOWn2mK4nba2mFzTY16Z1+mXz+5rntskMROhUgU0
fH5wKWEut6bLyLShuNMK4UakxNXV3kMR+pS73C9ZSgu8lp66yL031QDThLfLP2Hh6Dz7BbObIEtM
wZIiRhv2dExMs5NovJUS4kHFGuVscWJPBjv7SND1SRoxZbBNoF37grfLVe1KsVo7kmNYaD/+ZWAU
xblhkbyfZ46iN/pxipz3RiuOaB2OGc3U/eUQywP6E2J2tsQBpulCTwiJTnVv2Hk0UmK4idp9GL1c
DrV4B0xADdjakxb7bFOKNMKDUiPUEB8wYhSVa3zpVHkbpE+5Xqx8b8ufO5JvgGAmg7+5qCmboOhk
MeY4w5y4AvuX6VPHfrTDob2NtcrWwI3KurfVA28TS7KdYaPdaO9AalYy5sUpPvkls0/f96W+Gtsp
wwTQ2WGhk0Klg05UOv9H2nVtuY0r2y/iWswkXsEktdQ52X7hGodmzplffzd67hlLEI+wxsfubttj
TxdCoapQqNp7igUGViSK201ZnUhvxpi0ZIHQ0ERhVp+5bTvQdPwFrBTRGm8866kgEfhnjblYok6B
SW7UELdI7zMISQf0UjMA4wiIQC/EfEC7Ak1E8Bub3tAGXBP41JFn4SuOpFU1h6qF0HDI6II8hW3W
j2geUCoR3u+mXTmRxEZyEpIZRoPuNh2SIuS/EnQojBKVLcH9Y1sIEF5A2m2jfomzKInd9ZkhF70z
9QhP7NpPO9uPZRG1xfaq/SOG97xZN0trZkHMjO56yS3DB0ALTUSQ2xFJ4XysjZbUeM5LrFi2M5aP
njykpRuRf89uiUiSoeL8vWYad6Js1L0sCtphHLiefi93yQ9pLJv3Mkt/KaMWe9ftlmhSnN0q8t4m
WYilC7MPc/FI8gKYgDzyr0thR/PCjRI8eLHmfdQEcGfJsDqbxAvu1XkUa55em5GrL8kfhZInUthc
T1Q6mUmMIhXYogRkSbjCBSoIrkKwwqFQ6fp8Nq090XGLZy/haCk5l1TlRaIpzOqZFsiFVDwVAav1
rx6qQe4lVEj/b9K4EGDVhxiZJmjE3PYHLRw72tQd8JRHBRV9mgzGx8lMaEFIJbCBm8pxMk3u+A6Z
juoOlq1ol+e6QHMginrKNchVzbk+Q/aNeP0AlhGYGeA50YnBradujUNfJjhapY26qB5ktVVCF1Xy
MmQA5bVzC5s4k5bvrovd2kbA76GPH/WVgEHmlL9J9AjQBFD+fr4jhRO3z5Gyj4rvcb3QNhVxVW5e
EE7FcQ6sAorWKI8QZ8UAQTPurDKllbwLtQdjek0SvxicMvsD3TmVyZ28sQbiZZ5DZtSDgFjfl21O
Z+MOoYFsPdqiCoGtC7jKQPgtBjlowoidH4x5RkO6bVRIBCWvaEfQ+qCTkO+MaKodGZQ1IA5n27Ui
0fP9J+vspQb9Fsyf/akJTamG4DEsWQo5tf+q6tcG90oJDIN2g/OhSfulz+hg1qgnbd3KGIKx0ALw
F1NCBj+sU1cuNd+URLjRbNLXxsZpd990UalJ0O4VuVE1fCrNL+ksOEFbwRFKJkAdhfIJvPNyMtoW
xLHtAhlSjKashZQS7eJpxPt1PngoiLsD9ewkAM5RNs/PiVDOMI2FtcpzVCNEsqrXdJ4CKx7cGlW7
SVL56E10Rh11083XWk4OqfGhZeutrrzmskQ1IKSVwI/VtfXYhmVw/Vxvq+HJwDjDJZvRMI9ArXO0
GYC00rs67MYxyJcfupHQEoAZ9a2FcrBhf13u5kaDwYshh4J/jS+4KFNcglGejPWYy51h9TvVjvBU
LXqN2zYkeE+EzULZxUXGDpWiBSrvcKjHdnHAcOeg293r0TtmoEcHeJUvely5o4VK0jUWLO2WJ2dP
mf8RzdkwfUL+izAbNpjjTdI0e5B+CFR5exV/i+BsSDkxXOsMm0dQlQt2SpiQjNbI+P/JZv0Ww52Y
ukRdWY6MjZNks9uR1MvNzpsA3HxdzKZrO1kw7ozgkW6wOuba7GRvrL5dPREY/+yYDqCM3A2i7knR
4vGa3wPPpFqwP7nidtOtaR7N+ef1GQlUgC80S9NwIjULUKXqZdbuhWHc5vcHKKSB3mkUY/HopID3
Rbi4simU93373JDd9fFvWi2w3gAfCI0xgCA891GgiqmsvMMp7eXsOGUm1ZT02ahfTL3etWZ+GGdR
GzX7jhcO4EQipwNNYcoNUSHRXPYmCN5RbSDtjOonACquT21z908Ecbs/ETlCHQAExfb90BngvURZ
kQicZ3M2qKhFUxF7q+ddTTatUgo+ZJiACQ6myOe9vACeKpa/yIAa7ldZsF9bUahio+YHRGSoEeDb
pfShCsOqaNmkdp3+biuuSfB4ILDdm1oBgEMEn+BHQVXeuVZIVQhOFBNLF5m52/YTTfMG3hM9EdGu
jFsqVYI7xOYy/hbI19XEfVUnxQSBTRXY6l3ben31S7ZfFBHMkUgQd2+NJBuEpg2bmQTCit4FpFmW
fVcVh6yCV6utk6tZAM0Gcx+DjWB/f3IBi7qcNJY9olRIRWvv6KlE9H6/JQEP96h5ZkjTOL/nEmpA
SRJSolMFTyDOWqOx4A+KJlGCgvGjuQk8uCYXSOqdoq1KCAkkG51oQlWbGyOSlSaB+9l04ihrAdY8
wEHsi0a2tB/TsJkA30CUNytH4viXaR3H7CVT31LDjbObUZTSYirMmSEDwQIQm3BphQPnFCFsuyKe
G1DYz+ZrBYiS4r7WA1yybDtGduveFhmKDWuEqz7eTwEMDtI5PkupqsB6MxUAPctNMQYzAWYxitZH
+KVc9C68oRcAKNCQ6sXNA/XD7AycaF6e1MmI5lR0cBLZt+vlr1WXBcq9OZsTEZwRL5MRls+ACKVr
KNiD3X66H0UILxu2zgaGEbhDYOzQHMxtkdkMqZbUELJquBtGaEzGdDIfDw3XHcWW9kEQbgpAyEYe
g3eykVJoHVrNGMjQzQxGDLzYjHqghRRIIiVqb/LbOn6+LnNrj5BwhLqjIR9Fz9zcgJFRp9k4AI/Z
LvwyrPe51Qps6lbgj2n9lsElz1YjRvF+BhlZDYwBsM5q6CUvWWOc3/buigat1Y17P47+faITFUXA
riGoKoL/4O0SKeuE2FMLZL67MPyVzM+ViH58UzVQWYZSaxyqi2SFPIMZc8Ezr9PXLw1RaKT9sPIU
Zvbt+jZt6TlY5/6RwxnxuEzQotVDTlU7mQYa9TulF0T4W8VRKOFWTeQJUM2LquTz4ypZST6DfRDa
V1SPaxrWuxBoH+2qgdJB1qMd+O/WoJXr8lgp8R5kbF/JBOjDco2Kp+uz/cyoc0YRQwFkKnpo8HDD
54AUvdRCJZsBRJ7PUU47YnVvUxVHD1Y+1z8WvUS3ZTrVFugZTCNzx6607+IsNh1tQD8juLnScodv
XgVlZqG1v4FzOs52N1ngkDOjiibr+hAx0uFEqucAkIPNsY6j/tUAemWLOul6kqkcGclDOevGTwAM
k/d+UZH4BXXwW0ImpXZjYHQ9JmGmQIFbOoPFDeikanpfDewGEdaLDZaKMfGrbKk+plhaIopGB9mL
gIr1oJQNAplGGdQbFdgbf1A8guUDHBlj4CTg2DnfSWAHVZFsQ1vw+n7MlTaQpfIYRtEfGF883QO4
CfSYGDZn3405Ksw6XRl0nXVfA5hlwSswNcDzeF0dtuwiGKGQuMI7qA3gG24+a6NMo1WwU0ZAVkCG
HEmixWzcxhqb5zbqFrpGleqouTJRE+Dhnop6k5frg9gI2AjS5Iw5G94Tz4nnaxqHc50DTwg4kRXi
a+05rTMK5Odxep2jRWAxN6zKmSzOYOphPOrLAlkSuSFtYMT9LTgtc0sShNebcpASQaiD+PqCazQd
cQbXCOuaxKr9uKh4IzQkQEoRE+AHq2mUr9fXcMPZACAN+TBoOo4STwNRzlmC/mTMi4DidtJQBjmJ
bvYbhvJMBJvyScwx9oDpWwAQ7EzgS0vBgU2Uxe1HETX8thgklRBHwXfyIUGU2Eq1MNXX2+9tgY7i
8DmVfl1frQ2wWYYn91sIpwZFFBtdytSgsT4TFegRmrMvpbxXlFctDwzgotQjXvHuBhRWiXRj4+oF
4YhKgZSCKjS+sXCNpbzMPlGrzQ70b7upKwCef5eZN2bsdmiyvz7ZjTCYAMFdRkckqMWxquf7Voyg
711apvL1tA9TPVDm+RueAQ5VNB51vXTkVd8b2vR2XewnWAPnaSCXFeYi5EcfByd3knqGEAZ9KQGX
YlevcEZA4Sz8lay7zlaotqC5P02+R8aH3PTP9qLSWE3fYXrdwgBoDCpPyvZbBl53vZt2NaDycnUU
pHS3lA0JfISeDCoPrYrna5OjzlduDKyN2ieHCY/qVTXfzNb79aXY2oFTKdzJSVa7HNBzjcPZ1dOd
DkhS4J7amdZR2UzWvVx22VMmkyCywsKp5+nhuvgt2wB+UB19s4AogZE/n2QdRhIaiXCi0rkLerW6
04w/uCygr+u3CC6Iyse00Ex2aA05eRzl4imNJ4fVf12fydZ24dywvlLELgaPkaMvXbZaQ4k7SUtQ
QbP6ar3uSbEIxFhbJ5TRN+Meh7ZFjV+xxgrHVtUrkMPESlPRnODoAB7DmFy5yFrDH2PD9O2xmZ/t
oR7v6jzP3By4cfhHEgZJEznpF2rJcafSdO4B4gOA4sqVjVZanDZOswdQ8Gq3AI9AChac4fdqn8Yz
DWV5Poajtd7oaVgA8lpNI9qQsHnvQwKMrVgpetqbfXKcunZ9JPpUv3QpWW9GPJS7Y1+vNk0KE9ge
FTiqIqrVdZo6CK1RTgvwm/GHZuTR6FVqVe2kUiFuNMfhgz2pDTy8ak0+SFhLYNfqY6A1M0mp2tkt
skHxQzsCKlpWmnAvleE+qyR1b0mGp9Sr5pe1tfjrVBO8cZPlHhjDa6Abkn40GtxMaJwPFdj6ygyF
eDNq5wGFpmu7Ze3Wt6U1lYJOVlo/aCuS6xSQIH1IFyD4eOjlHF/mfFaCoSmyr1KUKAA6SEw8WEog
FRbYyM04yAYDtQKXA6Zb/rKmEqkrcwuXKJTGWUfwTdd3A5g79jrSP294Fw8BlFQOs1tLs32n2ENa
AqZi+fdsNxqehH+PgnNLOfKP9WRgFBNZj3NmAY9pCK4foS1bZJuABEVvIcjqeXbyCeF0p48trLKt
gLUuxrW7jmCNal/Kq++VXKHvzd7XpiiruRXk2UBoBduvisph/q2IECBFah2SI6VyVBOnkiLUiJbI
Ou5qWZRr2gq+TmVxqYtiSOfCGrGMtdUA8GXICx+wbi993rRPHZH+gNMA23YyN87TJTjn0lBBXrzm
M03yHjWTi3S0k+RXFue3ixXXLhA8Sk8ugZbSWFP7cX1Tt+wivgEwY1BXaCAtdG7hqwXwMXmPASjN
iMuQRiovXKbvodSJilG3LCOQvJBVQ9KYdfKeS9LnpkoRCMKV6eF7mY+jQxoU4PYaHroN8EXIKAlv
DeCeXJ/glvaciuV2NK3qKtRYaq1pLZZpTSxXzxAjlEjgiKiima/i45ZTWdxulm3bGamExQQyH81L
bGi9uz6b7e36ZxF5nkK05EpdCjlOYt+ZgHKfpkObfb8uY+sMnMyCh9KyB5msYY8Vi8qPpJUo7iEo
voju+2YUtH6JJHFGC6gGgNNm69Wj969aRkefnjXbWzpBGCPQAZ5bG1ZfW+YCM7LbyLNWvyKZu65u
Mz0DVErgD0RzYjpyctcpUVc19hl2SC4SOpCZxjUwNb2mE9y/N+UA8gzV1ug11fmrwBCRXlOZVdT6
2K1KtzVua92mliLQuG05yIEjxYprAK8NzbgAkKhmCSgkwsfhowVIlW54c/jxB1rHHsv/Xw6nC22F
hhTNwropau4TsznKRviW5vYNHJoI8kc0Jy6sjYpm6XILuWODhN9NJH9ohFKQrs1tOlXW0/82MU4h
FjRQNd2EiUnQuiKirZl5tfoSxiLfteWfwRT4zwryplxdsnzQISibS2oNsweEVSqTt1VbnC7JHoq2
Bnx8I8jniqSytT7Rd1xDYgO94bCv6c2Uy25tHkEKSxcF6CoF4kg/7gv/+opuHueTiXKeRI4nSwZJ
Gu75o+ridkcTZXjOygZRsuT0lajnXqQtnAdJhnZEAxzE5cZCtXBvjgAWA7OMiBxxUw6A3cFGhQrg
CyKNaalKZVmQkTdJdYhD1KiglUhCRsssRdSfmyt4IoqbUmFmZASCIHuhQTT3lznvUNoBwoHSac0/
KEYnyETilRNQ74Cr4ZzioNpTXZQwVIYGtuul+suK85tGVYGnBffY6rPAYG29bJwK5GucDQs4f6MM
r4KL9V6u9Rsz6Q5dJO/L4QvoFO9Nw6RKDDUtZByTfH9dOTc9NK7BCph+FYInjvPz0Mx5BSph7GIu
1W7aaMBi/B4aoSCq2dSVEyncBlaFWg19CikyQxkexr0cp/6Q4cJpVIIDvnnBQfkH8KxwqUXOibMr
NjIPbVRAltR76pi7mZog+HZVoPe1OrUjd440qv9BFzNBshxXaCBWskz2+Tqqg9kU+YR3omYJ/dmc
aqqA5suUekEeZ9N+/ZbDE68ssTSFhcQecTICArFvSFRP5UBHO0jD0THaHwbRvesqwjbnIkw8Ecll
rWdbLQ1Jg8gcG0ZiF9HvWDhd8y1VSuR1BPsnksY51tWuGeAtFlJnJZXPkfRkkttYf47RsasLYBBE
i8k51sksTb2UIcscG2+V3KX0+xWh/RvQXhrAO2bCDmSRRM67ZrXEKsogUVlSvzdGNyWRN62KG+Fk
h3PxmifzvTmIODTZt722hdyZUNCONdoVxEZgxCqaHC9PhiCQ3KoZJYjtAAqI9ne8r3CLqZYWrEuC
LGgiHePxrW2+9N1Bi1xF3aUVcgpg0PXXNadh+mjLMTWBaW4crGGv1SCLTZzrOrtp1k4Gw61zmxTd
uOSY8Gg+FcPi1dkBOWqBkM1VPRHCrWquTakxNZhxlt1o7QzckT8As8PjpYp+IR3V+hesdxa2Ku9H
ZBslLKEy/uz0kMolBWiOYPc21+tEEDPgJ2FRpmuokm4gCHVLtELjZaS9KabAdl0K0YHeKSMBrSJZ
Dl6YcyEt+tUAisUMiT450pgE1aDjcqP86205F8NZELxBR1qmYe9tVR290pZDb0n63L2uYZcu7VwK
p+4SCoCACIPJ2KvqFulbmye0Cb9Pxrc/kQPkbVZ7jHccTo4910aam4h99B5U7ra+a4lVU23qA0D2
iZi1L80TJgWsD1SOAJ8RzArnO6QyBOVZR/5+gBrEy7OGDlzLjQGKAAxs3ORxagWKd3mGziVym1XE
mplFuQx/Zq53uOPQnkSP11dwU+0+wfhMEN4YhNPt0ZorCxzoOERa/r0sJ/0d7S9hEGZEBHhzGaeC
lEpHPSOr3cZTEBdM5bW0zsqi4/0hq24A4TX2KLNAZrz5ired65O6dJMQBboo2wD2lKmqnIFb5aYb
htmAtVVu2vZdMV+UdA+G5EWDNRIs4EZIdS6MM3SJrEaVtEKYmruKfqsZAM9IqGz7Y4vuiuc29FYR
cdTmUp7Mj9u0ZQIdepKYCMPzkWpDQlfgbCP+GMOdEDJ0ay01E90tBA8hpskzFaHMIRwrycK2VXSW
NDoTpObHBhAuozu0h+L9+tZtRPysjvK3PE7ny8TS69SCvDJ77XWay3dF/Q03DIdUt9JC59m3B6cj
AoO1dbaRvUXhHqJTvFRyyjnXsxRnOcD1EGGEKUDlCWh/PCUmNKt3qvxq6/vr89w6d4AuA1wyMEhQ
98YGdOJTwPexZksDgT2atNtvVvU2hz+vi9h43tblExl8grEx1FrtW4m9obfPa7m6w/AX+Lu/6Sxz
sSgPSq0fagNM9/YUNOiNytZ31BkKHM5G1dP5KDizmeZJjGFgptNUO7XxvQnLx2KufCUsnQSseFOE
cPkoSUnQjgPwxXNBEc3WYTldBU6hskoxCjQGsTiWeE1d01V/X5WjkT5YsyA3uaVFp6I4d1QhYdhY
HaYqIz/d1i2NLFcbfmqdj4Au63bW+CfG51QiZ+kqQ0utboXEbHlJmwDI31FVUAncEP342lmRF8tO
K//73Pj5lnImb27h9FYmdbZeK2TcdJFfFy0kZ+DsQjG6jhG7dOUaU8CSghZ0pF2ZHEet8jQtfCtR
vbmWxtP1I7Nl7E6XkzMDUhfWNUp6YQa0kRrzs5711OqBLB3/StN98u9v/mwdcQ+3FBQLo0zo3Ais
fZN26AvDzaP4mPoRF35aErdQXq/PatvW/BbDKQlepEfFYiegX9Nd2C23eq97stoIItitoO90NpxW
AAYikjsNYuTuqZyYU2Kvwo6Vmrvr8/kvJuX3hDj10JpwSYHLjVIxJOTnvPeM5N1cXdUKtAldYT67
JhrOGrt45BWEFpv+CVjgaM1AiRpjmDnfM3vulGrVI4BO5sb0q8j0OTCzNd3j/dvGK2MRjk9SrXfv
66g37tgO1Y2O11yvTQvJv74Mm4YNj84A7QIEFjh7z0cixXWW2RlGIsm/wBY1tX4tHSokwmRRPCWS
xCkQK9BK4wKSbBI5leWV9Uslf4ma2KvqTOAvNo/+yaw4LYqQBNCHOkYuM/fRB4Ue80ZfUDxU08JI
0HL+riRv19dxM4JD3eE/C8mpE7yzZK0m1MmwApAxSoMngywgNZ2wdcfhkSy4ow8iPWK7c551wNk/
EcqZGtKEyQCCDuBZ1Y8WqgFl45B37/mqeJ0S+WXbozkBaZdHlLm25CYTVUCKtpRZwpP4Q8vNIbFa
LHMBYuc4fWEgMbjG6LpnJYKXwc/252tT5WKdcDbGJOswVasd3GRaIRPC1vS1yUynJV8LDQQZ9XTo
jSxoVPOrBW4EGcDa4zwd5fFDQuE8bOc+l38QJXbwBhNosxSkSfjUtOmh7yonJyLW1M9M6OWgGV4h
gjMw/nB62GgL8Gt7MC4ZyhEOz5nAH6PHuzW9wzEHq6mN4uZxfgJZsTm9TOTGlN+tQQRFsOmPwOD3
n0FwSqI069hio4BuL5ngk5m+4XKagAhmcQe5AQZq586DYQlUc9NdnAjltitRi6zKYwjNWqo1mDne
JGsRQxx6izYPwD9z46/TAwju7dGAmHrILGD35M2CVn1zRVF8rIC5q51fQcKqPCnxVE6ONcX9TTck
cUfTIhl+6Uqq6zQLF/JdBvfsAQD25FbuC7unUUn05XGdw/5rNWbNURm7EE1tltE9AVho8BeQkMW+
OmXErQhuTn0ySwPt65oMNAZYLphf7Ly5iVKj36GARDtUVoPMUiMpjzOQVJ+rdkiQcAJz1i6Ma/u9
6KbwJmsjFKBXUzi4y1Aja6dN611pkTxIpZkEXdlVXhcamYMMeXhbpJ3lIkHWugta/F5bycBNwyRR
cpOjMOgerOjWX0D8s2+LYa0H2lm2ijb9arRMPzT08kaL58w3Qkt2S1R6gjMQ3ftT3Wlfkz4bHqpO
SQqXoEcdL2hr6a59Eb9I6WjSPC7shz4fF4tqegvAPnNdlR1Yqo0StY+L+UPGsh3iJmKdu9Ygo4iY
1OBbbkg872yCBzNUrFmAOmXENgMh7Zu9jssLGAaaB3ue4/sOrZg39pgp+wY9OF4+jfJH0qjjY1W1
8lfwXJE9WC7wHUO7Lfx6sbDp66L0+xZp9JsoA04bUCAjzUVe3X4FbkR/GzeLWQP2Ui5/hqDo8cHu
NIROhLqKnWIXdQF3l7f6zZAuiknVuCeln9kLekDbMDQARRdmw0yRyFYXaqeq8rTMXfSoh2rMej3y
8K4DzdYDrn8gdjUbu/hmtVHY0SqN6gQL30o2oLgtspP1Un+Qw6y/AQGtdEvMnoHVyHbqAYNg+TA7
U3eqFaTywXXvtOkPweKpmwCIRqMG5+WXHNoMwA4wBfeVTvuluTX11fbCYfqrSO0fWTscrRKjNqpl
f13ydqhDkET5LEYDgsW5j0gaDZxKc4G2Q6XzQ63LnMomIOBtdL/Vxgg9oxLMMZ7CqZwDakJScD+v
qlJwf9u0Eyej4L1z31a2jJS1g3TyHYDNAl3ar0XQpJN7fb6bLvFEEGdsR2D9SsiLA467GQZaDtlI
6zQ8GrL0dUhsOq4iRsTNwAMV2Rqr17JtZBXPF1jKMwJ4pRR4p9NBUz4BfFrrWYFJ6iNEjO4436aW
9+9nyagkGLsfPvk2Cx1tNkO+QKbcfmf8b5PxboKQ0R7eDdEj+Pb8kOAAQbwNzCD+fhPFoBBDJQbo
iOSXaAYsxcHIb2FsXRtVW5buJ2AOUhTBBLfcF5CZUYYMxgTlgvd6JElUj30Jeom1pAaAa+M+8Wrc
eq6v46YYFM0CWEKGIL4OKRqWohlDBDXVumszWG/pVu0/rstgcTUfgxgnMri4G1cKjWgqZERW3fhK
i/bvBhxuggXbOmCnUthMT0LBcFm0oVEgZZxagAU2oNXNnEl12zkSxPbbCqHhrovXLmTt+Q64xCzr
VJIgyphab50MOsGI2s3qNF21N5repCXSF3Fru+BBEh23zy35vZx4eLPxRgAgfGTcTAXt1NxyAj6+
AhVzUTh++lzc1vTO2R0eD+4HcXei+p1Ps/xblq0qQP1C2z6K7RGPgmSbC6JmS6qmJoGrrN3J6TzQ
h7uzK1GJosLFq5zYBa21Y+ITl0Sn92ZnchUnpCmVae1I7kRDz3INdxDswCeO2sW4VAOvO2j2Vy4e
MaQ8kifJJhNtPDau0R1dVH07Hca10t/jspzEQXDpLP7k/j2qzC2dyA0dy7WdWmB5L3CMcJWW0SaF
ZmYgKF2WyygTHDGSPjO1l32SUyVyW0Jho8znzlfuwp1UHEw6YIVeY/r8U7QoKn8CePHcZWiU07EC
z8dMpZiCLkh9tC2n3H+7rxxEkxpwVmmyD/1692N0clpSaM5CP4CV4IjeSIAKxx15YG+zumwV4Qty
rbhYnx/Gpli7UWtSk7que3DdW/dwi9/57MP3qb/fU4pfbn3fx+/ongY93QcBfQrw5T8/cFcuv9Mn
GuCv9/j1Cf8O/9Zjf48vDvtw8MNlXxyHus7jo7vDx2EHWS77gk8HH+yfsH/K/uD+PLw9vh1+Hmq3
xp8OB3z8PLD/BeM8CDTis7XxTE/RVyzLqDOCNmiqQvgtMeJSnvPCpgat6Le/lVO7712LLl5Ck2D0
Ua7uFs6vyW8cW/PC5/UmD6bDRAf6Vrsy/fhpO5FvucuNJBibcqEuODmM3QQMfzKw4EzOYObq3BaV
lMfO4UtBMxqxpf7x7njOo6Au9ALxFGcUEAk61MFEgzdknWtDDKyG0ChJ7KhB62LTg+DYuTnFflx3
NJ8I/OfLfS6IM42Tps7ZkoRA96XFp8kCkim02/Q0/EnDJNlngZ+HL1/cW+Ld3vt0P7OJBw8/dHrU
aeMaXu0Z3g/6gDCV4uWGvgfes7N7/PnzIOLeunAk7EoOdHENhUzgecYSnS/MMKMXXO2QfKp/pLqD
7jXcyMab5cv0ff6aCzz9xS5A/aCLBAUc2HRsBLffQJ5RxlWqYueL/93f/3r44d09R0LTfFkjwmp3
QPCF1ycQMFsXL21SrQ3xWiTOm0Gx15QesbrU8XYCrfp80z3dbDYfxEeg+wK3MkPvPV88NVTzSsX1
xoF5ufW/3P79w4dVuYVxYR9/GwpmLJjFCJj92OO/s8/PH55HvZIejw7MxuPu43HnHh5hHH6+7a7r
5YVjwFDBgW4yuiLWQytzbrRoekMPqwHMi07nwOglnxbL2Ym6Iz/fwrg1AaoY2kGBj4ScBO+v5akq
smLB4jNrBluLSXtUcMq2dhhQdQoSfyAVQkzA3TBajRRFk4B5MaOHw9vBvf3mB+84Pu+eYIsVdnO4
mM6JJM58ymWkhCSGpMPtLbYNtukPNgZ9xgoiezAjg/38XIeSilRpl6xMgOt+ufV/0QDq4OwEtvYS
qAAKcCqHm4gyFlWcVZBz++3b95eXlwhhygsMDwtWVvwef4Jo7+g5u+eP2nn+eJ4o+/mx0IXG7BfB
k9tnjSu/tCgrQK2EDYOs8mCPLdoSwdOpQFPYcdnfwyXDR8JR7nZwlNeX+TJ1+jn938KYKzqJzScL
XtBomDC4fzj+J3h5THXHHPR1URcugB01QHjbgHv/dDbcZVRGWmTpCUhOWdTBoo09O/bs/LMQ4DMc
EMncXssTmer59CKSzUPX9JCJ8nKKL4C8w9c3zDZDBPoreA8ejg/HoyfYxMvsLjdZzrEOzajGcgbB
sIAV9f2X4KtzJzIqm+f9dEk5Q2tFilq3CZuee2tRAuv5EEBTX0Vqcvkgxk2H81BmkrcKmk0h6Ivr
7wPcbATacXGf+dQOEyE6uzrZFwXtWlqVUrb8vVMHi34B77jn+nD+tffj01Q6O3YGBPWu28f/RCx3
/DMtLIpVgVimHxn9Mjhf3tAsC3ewOL3L7i+ICP0nCk/Joo4eUQcN3gH2+nmnyikulPiJ9Rc4pk+c
sgsrcDIwzjHZICBeAefw92mBErm3n19wcNjhYR4VrpIdVvYFX/HjiF8/D9Nn8I3VwjEWnGF2Xq6M
ii+AlpqwGeSzUbGRYUB/e282CjYWdgnwPj2paAQaU2l+BMAXQPUV0C4Qx3DrUlUkN/QWrZ1M8Oc9
hV1V2C3kHbO/c26YmXQffVFQ85m3OhOMdlIDEBsEd1uUUX4+N5xYyj4tpTS2NTikit5HNKKFUzgj
/YXfrXTG14hFUx7GQDGU4PjgPO2fgr3nYUgfH48/EXHtfdgeXHIOuAs9vr0dHncD/YhwF/8pjF8v
co0q4gAg7wB/FuE9Ko/ODV8jmUY6SHIGAjG6fgk/Oqrt1u/592hf7dOnmrZB9rK403cR2cWlQ0Gj
BAE3OCoO0EKPBOC5YClHn/yMBlXmve7hT19emEvBGjwvFFHVTrQvl4EVYiqEmhAHXBKgknACw1jv
0SyqStQM1h/JLt/76+6XFkg39VvifAfLhmNSPGM4gKcSxe3MiJ+pBAvn4KQRbQFDEUHK+VwnMzYl
c7Qg+lUNvoxu9pbvpylQgmxfBt2uEdiEi3uhysnjnHVTGoOs1pA3+sqz8mX8ojpPmRN2rvpwnI7q
0XLlwBIc+f8iFHXx6LBgGRRG6HCi960+SOkUQWieO1bkfkse1+O4+9GBu+SjPMAC+nhneW1EASZ/
B/57rr/FctFCEpIEDFAQS1RneXosPmQHYNNOIh+mr++LW+xfUcgiLKNn1uNiR7GpSFwBqwONx+eT
HWScmZVNdiW0uTF+qMES2LfNR+++PKQ5Xe5jrDGSRzR9lQ+md926Xlw6P+d8Ip2LVhrSrY0OwG26
GHRF7cMbHA6QqUJPCtR3EeTwZ3PR5VzxPIC7roo8Nqe9VZGg0ASQRDQ9Nh/Nmwpzlh/MvRLMT9WX
+QYoWk4D5kEqMhGbghHY4uDgAoHsMye4y8JxqCUILgoPpRAeOmiaoDwYTzmdjotv++Rx2s1B6gmz
X0xX+SmfSuasomSFoRrqbHsxN6re1L7+0FMaHbvINalNX7tdGTxqe+NBtLefLbZnooHwAXZtA3SO
SDoBa+tcs0bwCgESvUBOZ0aCM9qRe42ibcgNfcAe+skh8/pD8ag7EVK1gDR/e5gC4MnDepW0eOju
oQOH0NPv7tagdKq9SiP3NRfcuVQ2fX6Mn6cc91RUvF9UUK9dl2vVAApF13ybqeWBnNTT7r7ViIFQ
+Bf0x+RmdIp9TNM74zF/IvvChRkIpJfKM/aCw3ARaoA8AIYdxdys8h63wPMFI2gdkKtaj53Zt1Sa
dFT1Qrf2uihYVCphDdf/4+w6dhtWluUXEWAO22ESJSpZzhvCkTlnfv2rMXBxLIow3zkbbwyoOamn
p7u66nPF4o07n1mc7Q5fA/QqgRqJXjFW+MgAdqiXerbz3RLHQfyQ/h95aXo5zWb8apCzaKaBMg1g
2DDZbjNmX6Qw+KXpg84+hynEsQiXGmiMsv8e6O2rSIQmMC5nTcDUSljx66kVGHnqskEO9M4oDz5R
iLpVjukdKAj03oq+ZQNAA2SmYzc7fAtmTw6JzhL1kJK3nvjvf3/MbQZm9jGzSw1l+lpqcqhSj8gH
SrTFTRwJSCVdaJ69N6ZngQKl1HNUBngi58T71+Chmf3ZqqNZgC/rCZMxIheZkvpQWbyZ3INA5q7Z
cJvJfgDVgJUQCKwYzQE8Xdt2k+naCrbx1iniM1SwDaEajpzHTUtB5SPoDBskopqPWiId4OFOuPNN
1QnepwN7lGxfTwPT1Bxu7aDR1Z7twSvLN7sB+Imyg+XazBPSPYvfrT0dawKQjLRnXku3DnHK1xzi
bdyGcI3jwEKDJDfUbOebkB07OWIgVqZHrmBETmr2pmZi6RkE0oIdffv3yr5TdfAbGcNHq7cN+Xvj
LZyC6w+YbbxQk1PBQ38xffpZzGYKCeeq3437/Kla43Yw/N2wE795UySAXWW7+F4Ey5LObg8Nyoke
AVH32hfdXE+YEhrEookP51JhZ1+UJFMRtx3irEDQexMd8UwCV9y/TUQ1GihFktGKyGN8j0jE1z9Z
aKWufMFN+EM/gNLkgrMOW/Dntfwr1hPVgYkVCR/QhTiC1AeIR//Uk9XY49bvXRuajbQUoyThIbip
S5fEVaC0QMqEFLvQSfUn/oO3VI14K7fbbUpmNrjZhRKnGXiGZdhEAeKe3bK6+NJiPr/UY6hXyOil
79mayaX5BIcNuloQ5dAg69rRKk3JFB2LUFl+HY7obylRVsJ93218W9FQ/5xMszdG7KrUWNtMC36V
EyS8TtAPRRdTnl0tqlwNXKg2iR5vopYMl8zSdGDtzBospzqDsrD2Ncn6tPetYSL1bq3muTjdv+zP
3w1sFBaCOMA+RJzOiiNXuE5VY9JzuzediYL+OP3y95FecKJXY55jT8Khi9pApE+TnABOT+Kt8gyh
4fdYLz8GDN4IzMH0nor9WmR52wqDMwuyIgQr6DyT4M6uV7oJebSbTD7qRa7wWVnTc7oVHWFf4Uoz
gUPJSLv5e6wL/vPK4nx+o6bGIQIaTmdHXXzNN4MRHce9f9dtEpLuBx3eW8/OrBU+QOxJ2a6qpdxk
GK5HPJ/rLOI8NpRhP3CYo3bx8fYtHyMjdtX70TenjRKTTC/v+cPErHip2yfpzDT1Lr/c1MAFcewJ
dOh257LRBm81PfwaNdKia/3YG8OW3+EVYQj3f8/5DxvE9VUJBls8DBWUz6F0MT/PidfKDJ9UsS7a
4ZOIuwljdPO9gKfSjjEhGuNo7mCIcNqAfxgT8e6fwWXsDNvw3nsuP8WVPbBwxvA9lCGY6kwjZp+5
NNDgTJKUADfnncU7zsq3vtlpQFXwFuIFKzaKnuhrr4TbaqXIIypHURT5MBQpfpLSv2a/Aikh12lZ
rAsX8GWPtgRoh/iS29phgit7rF0w9K0EabeJbmqTB38REgKAcvwcv182Iy9QuHooYziTzmAfhpB0
RASwRSXY4K56ZOFFmV1joUK/ttluXwUwDRI7qspBlU1m8WGexSK4iDHHyK2QcOOb/IvntpZmo4v+
Dg32Ky1eN1gRVP0h5gXSVlRpsaoqf725BTEZqj5maCwMX2JVz41zhLSSqst2dJINRQ/wTH5utjLR
7OI70wtde4CKDxBG4RrS7TYhgW9Bxw3ynpTr94aGrY5qoeain2/hdbSCSj7JNoCnQ/TiGL7/fbhu
awwzYzMXmlegsc9TGAuAQN9Un+k21hVd/GCNyBzsNSbjxS2FmBuBJ1IfqDDOzo7IlqXvMXAi/LlC
BJo476Hu79GOleIZxJ88q3bAIqke/ONaX81tVEBn9R/Lsx2lVVPge3IQ61Viga7/23fZj+oxspWV
N8VPS//MXV0Zms1opsWhVwUwBL4J7ZI/WpONHBria5HIn+leusPbQq8O4EeUD9XDmsr5wm2McQIK
RjvPoLo5J7usFabixQILus/vmqN6EgtkPEpd8HRN9/XoNT+Nu96Rkcd7WtlKdAZvBv7L8uwMSVqQ
awHdSs2zKpEjMxHOlg1BIfkHRDlGqyKhUe/C98juMn31QUV//S/r1KP8clYhA1W6ANUCvXwE4NHf
HDkQ/D32RrFl7NBaDbSWHBTwBHgvIMRE4n22nTohAcVVA98on9M3vOcP04YB8q+10NHY6sXbGsXm
4gXw2+BsW8WJpPp8CoO9zkG58jRtTt0OvRInwUZSlnVXXfDtuwjjAme7iFcRKi/szGCUpJLcpbh2
vXN0BOofbqjbQmGMN4VP725l79Cnx3z1ZLDyUtQB1Avm/n6Uc3HgI/j7VocQQZDq7SGzwARoloZ8
bB3o4H6H9+1FXbvibp9EPK63f+zOBtlNSsAUIexmgJ8dmhMqGsM2Ip+syyMHxMHPrxaJlo7JL5Pz
Dhmv95o40DCviTO5wk4wSl07aHphhk79wX7wRHHHjYRTezet3HJLkcvv0c5pIaK6F2soNcR6/Ki5
4nkwNMtDvNy/NDvPSrbd3UjWbNIJvF1YCBBoFFDFzx0+18rhICVtrE/P/aHUYzc+TVtBD9ecD704
buzQQAE4HCrmNXvbdpESS0EEOzWy29MFqXwr3BZPWWH66EbbjU55iR4gfISIzfl7784AyNiuuEJ/
0F2KAJDFDftW6mn8lDUDYhW9t8O7xJAsECls5EcLukR6t5efQyvAplKt2n0YSb3R//6Apcj86gNm
Yx+kUM1lHx8wGHsAkD/CXeV8xa7sRAcBSVs5I9s17q9VmzP/J/Dh0MhlD/+3DzqCEpV2jCzZDs/Z
k7RHXpGx0UHOmSGwmiujpdWg+UorlGoYeghUY3d2ZEXZl2qGjrZUaL7SlI3UZb6kbX/f7lZTJku3
CtLgcLygCse7flaaigc8McdyQryyrTodhNwG/1mpeoeI128IFxmVtTK8JU+oKJB2QjQK2a55oN9X
BTfyihDrd4lGpCPy7y81abINuxPOqVGZ/B2Mb9aO6WLYAHw7oF+gwoH61GxWMzEOpjCn18tZs0Q7
v5s2lEbUaUx3NBRExcQFRQ66ktfCpYXxKgKgebSiKyMmnGVriqFLYzZCC12KezP5LNzwbtzeM6iK
DRvJqpCdUrZ43h55kh18i9md6atjLXb5sXK9qZAqQkEZunyImdDzhk33K3qQwa3ADp1MMwnYxs4r
jwS9UZrea22PJprRyOOe3wqWZMJfTuQpxTbotr7RoHzFRAScaW+e6evBfrTXuC0XngNgfaa7HTJn
MmhMZmEVREUYkAkwcC+PBW/6D8I7+zIavLwXfbwDV3bfrbsGQF1FoQJarEhFzovrSsqMlZfLNF1X
P7Zv4HZ/F4zgM0cfItDyFWDRnyCgf2r26m5NDm+hEAY1LUoaCkZBfIVMXfyvNUAKVCvRIhXrOywC
cnYoB9jjtnJq5OM1nXkIdeRFXdCKH5jXiuRmYUcucuRopDT9FSdz01CBsQOgCEZFNFRAPm+O5OBq
mmnx8C3C8TXUhefavCC1Zbfm/QeFdoR3H2ltInlPc7bgjRKN0C1Iss0vvjWZgqmcMls1V9bm9qT8
/iagNK/nhx05v+9p7qeHmA7pTZDnmM17wpLTaBRAaoeYiR2zWXO4Pw0012cD6UxKdwreJcCK52qS
Q4ket1wLE716jt9EvcoAx+oe0URq+a5wIGWviyR427aYq3oLqbfvb/Z1Nf9B3cDNRygQEsL2BN/k
3E2MIJ9ShzZKdA7iIujZttUt+4b0dfyY28kuC/RpO3wPtcWTlVm/DfTRnkmrx3DKyGXPIbFRJoSK
2qB0nR+4XWpDQMtgGUDSJLSro51nisiw0hq5kGS8Njm/WzmlBYUITPJ25oR395njo5PniXYVFd9Y
azs4cGfuVUBHUYXmo8+/R7xsXqMdTpQS7UbqsMrUUkymHvWBIxvo/h1lhsREHzRzOoR66Pj3mg0e
rN6gmV3vkDv/IYuOCfj1BTNvrDBsygwRtKAHi7OkS3AfQAHDELelXezKCCgNXdnq/gv7XBFt/Qa+
vfNB5ohHHW5ZAUgjhZ7DX34oDMA8yFcYP7Px9vkbU5PhTqxM6OsaEvqhSbqax74NXmERWCoWIj7Y
aD9Fs18WU26c+prDgrNn+cw5CKj4c/2VAqOwkS+NYjAPHvBuOnhkjVWvsnSwcL4RNFMtH0DXrkcb
pHQGRClB4Jw9Y8Mdg84CJYjhNwYW2mAjaEbo+fvqA3pxzBo0ePDKpARys4BDLEZhCgQ65nSnWN0z
JN4IC8GKiIynjNQnyZYvrfGG9u61cHlpfdEZKdM7DuOdwykzKfTVPED9C7JM5kAEn3jI1092a8Wf
yEzEq8u7ZnDmuGWoyvlsBoOR235njrftdo1PoOY+fbMQyiBrqS5+yaCCLjMkzRG43sD4xVxrK63k
UccE9ZalXDQSQniFyAE5ueTpadIJoPWmTDbr3Zi3D2pEcb9Mz5Y1SnvQuw4wLRzb1KjvGJ05oO5l
+3v6li+dQjfJYPqX3sgeRNcHouRv77UQyF59wFzRO1PBjz0xXKKrr9zFP+SPnIELOrp8Ma/1iTtv
IVVOqv1aYX0hsYktTHVOBeBZaDH3+hjlfu/5mYfSMfKoJVqqvpljiFJ2YWU7Hs9dVzF7WJ9M+RBs
V1E79MfnlyMImCGxB6YQPIFnk871ea2WtZ/q6GbqNIIxu/Ee2gmxExuR3frk7zleuiEQi6LbSAZD
OVTOZpFaKidVh0wulM30yUImQfe3/le1CZ78c/GOrS3cqQXhP3n4DvgtQKcyJ376+xsWchl4Mojo
pkSvExQ+5wwKQiiBzkTFN4xb9kt8KWmBF91qenwv6e0OTBUmxCjXmqqXdheCQqQXoO5Gexlnr5Ug
YpqM4QEZGqzR5N+8V96cEBGmueV/ZQegMo8acq1OdF5zIrdZI1FD6Qu3Erw0NCVmS1x5/iSUtLCL
mgQ7kkohsuO7YGtXVxZ3YYgSaueyjEALFSckba53cpNkXJk0JQKekUj3KPYZ7GO69VxlDzZMZOr3
6Wemp7tkuxpo3m5jWEbQQRF7eHPPM46cBy0usUIhOXL4V+8NTYoucJIXDcU8z8ifOxzcTd8D+b9N
j+Ih+Fr1m7eTDD1aJJFADa8hwXCTmmNSvMBE3PzloT6zaBx+0ABQ6u3PZC8Zeyj/BIZiP3Eb4jsg
O0czZIFqZKarKPCjv301U3h7NSPuVJDkQOiJwHNOHlxAj1UTc1zNUQsLcCWb3AU9bbHzNj6PQhSS
hJkNJ7d2tG5DXkT6KKtrtMqJsthsB4RpAaQMSG50/tw+YnObAtT7DNaZtrkFFU/2vt6sHObbYICK
akPbEgB2gCDncPKu70sobnmJPtooaieE1/M7ZZccvROgWd+ZT+KQ8ICNMMYa5HnhrqSmKVcHGhtA
CDUbrCjEjRfHcNzcRbqIW9FkzOhdPL9Lhw4Jbz120CfebsaUIPIVdJCG2f2aP/0BOF/77+tvmMW7
ERuCMknDN0gfAjBAHq5rWmkNecIGZvsur2W9F/b51ZjpJf4r3gzCJOiiAPdF4LT7HN00hudC1w3B
wjYj3Jmxx6cW+JhH4b55WVnp2/jgeqgzB8pAGi8ReQy1ega7nhOqRveENmMwL9GF1pu72FrbXAvH
CMBylqp2oKSK2v31aBvoaFdjiO1cgazBc4r3CR1pJYGWAPGPkl7s2buBQYfaykgXTtGVWboIvyY5
YoQIPbAqYEg24tvNYPmEVLtBb5/LS7lbLTvexnyABfwzyrnb5phymEoeQWZNfBs4OowPZZsDzk1E
UtvDffwMOQgjuLsI20pPIoMyxUdrl8fSzvr9FfQrfw06H9qi8QLM9YS8CYn3UAPVg4tmfvEOyIbQ
AFOUpN3thrVttTzZgNDJ9BGlzctxkBNQ4wo6ymg46Qxp0x5SnXlL8WLzCE2XroZAi0eWSv/+z+Ds
Pm7RMMrXHPWRNpdYnj3c+2cA+CedQ+PLf4HRYXVBc0JfSyxaJGZ7uAUhrD96cJCtPnw0WMeUKBY2
MeEvIXBdxXnQ1+SrFiqO1zZnG1jNwPYu+ziqgyV+x7veBJDMzt3kUDqAIliSs3bh0Tmbu8Hfg5zN
aSI1lax0MMja/l36ELqxM5iFzt79fTIX9+g/c/kT3f7ao1IRBnJfwUxnKVYbkdqSMJxuZUuuWZnd
K1EWjJxQ0tn7mAz/7Ll8jutLcP4ey8qU/dxuv8aCkrDXJD2sRK5ng+jlqTYgoGeteZeFJPTVXvip
gf2y03Ji40cD7IhnDs6s2VUmCMOfgfw5/z2ghV33E+ACjI0sPCCUswvC47SmCDoVBUMOryi10NNv
DSDVWqBdOcors5cvsZFv/ra6EAXAKiVEQxigIikwWy2adw7C0kNRyczukXrWUytC8k1zE6eWgcvP
NkL2qNiFfu6Jhuy05q4+4m6XEj33GLImQWheQTvutetka16Dnk6KIICkd/Ej1xHfjDgdgQAJt6Ht
gSFEAIBj35m+lV4g4Pr3FCw8qK7t0+/7tcRlMvG1JgCp224nizMSS3zhDqPFk+RB3X8q9tvnisFb
n31lcH4OW3aqwHUHg96rxJEeXNqP3Y4jmintWyT+vlFXWRvjbZxJFdvxVGZRaKDomOsxRuzIVNKA
Za4M5hKdykN3iRRDdsGt05HJ1l45PTZKTxekVa+zkEYHxwiWF+LnSG0in35tu0vLMvCbFmnFS4fA
3X3OdWUCaFQE/cGh24WgRZKQkCqN9pS+B6aKLYjckLA2BbdVBHwGfd6A7hgyn+osuyn03pCrDR6S
mmdJLeH3o/6e6nhP8ictM4Rz6YQu0qrOmtddyJAgw4jrCyGYBtrDeXmn06Qq6AskdVtU6JWNdvlC
480HpqBCOAbwmc1u+p22KZ57zVi7WZY2N6h2wLQIsjBogc/9V1SmKsdomPzwTbuH+IBMJlc28NT0
kZlBlNSh00a11tB1t325NCeDpmDkGumbfW5WbgcfvJJIcqqdMZriPjB4RzCy3WglBoVlq0YA4CjJ
M2g3GpltvG111Vzptl/ApF9/xCzaD5VCqkR2pI8rPCRxst61nWfU+xBdydpeJeVn/OXyJD4Whrpy
1f4M8PpKv7Y9321lpYLtFbax4cAOKL6+orz68iFt1SNCQyKf0d32mp7z++YwvcshSOF1zvTeVjzN
7aPj+itmrhViK5kg8/gKQMJeSsj1DaR4Tx/c7pH5VjfiXROjYve3TX7B1aB1F/3yOG6IE38AFL/c
qRCGEE6dWKRRICByLKHdbTegilOO95FCPlgSfMv3TxVhNL0ywXtpoMAKlFyLPSgf2l20Bt9egCUi
E4ydD7waB+SlMnPvciMpceCJKR71PQg9yeCqjhnbsY2eI7CqoP2TwX7oydSSB8Ze7QO5XQKYR4oU
BwKiTnA/195PDLtRTjkZR17axb0BBJvVkeEc7qdzk5CSsd741dbtBVQvzX6jtIGk6AIWciqkvJFK
CZwBpCbtFlXcJiIQLcJDtwUk8wiWPACoi40AMrpqRJk51YF+hZ464sHVPvLbgPD6Y/jrGYgnqHsm
NT4GXhcIvqjDK8GHp2tOkYX1Z5+VO2BhQcsX6oeVq3YhvLm2Pbv3WjULuTiD7e45/h63BuebJRFP
7cuH+jnZAx5pzaZ3ZYVEZ8XO6WN89Tl8+wq//oSZF2rRfVRUdC1yU7sIzx26B4S9ZKO5XB9MZn/m
z8UaU8AtghE5LCAmINGGNDUye9cz3gJA1PtVjtROY4+01bDew/Ue69qMT8OasYXxAaYB0RfscNzz
8+vd80AflOUKVAIPtR08ieB6dPmWsJdT/ByYfrRB7FyvXeYLe+rK6My98kyQZmoKoyDSsv0NR1To
g27ql+JJ2fMb/ihB2R4MDOmOoynbvz3cwr2CegP8iUr7nXiAsa6nV9GmofBSNUXjhWeX+8hRtz6U
wt/5k68P5+wxNCQnfImfwktkr+WRlnY0GrwgrIZyKQew/OxBPKBrs6+LEhennt2DWxudOBJntAlS
Z3WEJlrawxq7vq2CwC4x4eafMns1lrqNYHGpo+QCbCOgwOinvJ6BrqmSrGHwEaWZBGZ0Sh9Ul3V4
SAxtaacCB1Wa/xDCXtuc32WoTeSMBJuVq1xAIUg7vKQ7EZ30KVg98fzT1aOyzXT23ycNrw3PlhsM
4aE2BBXS3efk1Bm0wvYi7XhkaFVHMdH+ZGmP3GO393TJWNlpCwdZYeHDVeTLACKdN6KgVZlSkED7
1ntgt8VFpuZ4q1TRATSu7epFW7inQGeLAheQ9NdrGqbdCHqREalIyM2hJs28aZ0B0BHy/KvjWvAZ
SLD/Y2u2f5gpjkBYDltAH6eHdK9+BhbFkPMWf9RRbdiz7+yKtt7C+5om9f+xOTs4XF6OfM/BZm4G
qO7kuBkDg9JyCfvg0JCtuprdXhvlbMcyLEc7BFEGVHDvfrCPsY8y0ugACWtoYPjk9GTbOmvFpIXe
wKtxzjWG87ST5GbAOCEpVJsomUGoQhcv2S4yTsq5BtXj35v0tk1NAoMJ7bxAiz980vx9UyfiFPFa
mCPClizm8D4Y6VtNKlS4y5rY40f1dEfPZrZz4yNoPh4vzH2wLV7BZWr//SW3S4wvAYAUbHYcPgQF
lestHHeFVhZVAvTxhmls9cyCmph/aSQiGyI4XDo7/lgJMG7biGASWROMnvJ2As95bbLR+nhQB+jP
T8fAHazOgc6Ezr3mrvgB8uM1V0RDpatXxcza7NyAYNbDDoa1xkJMvQHs2OZ21W46oJ15QHS3Mp83
G5ia02QaSYImDdCg68EpeEC1bFrmusCBIKABAdBEfjBgMvRy3W476W94WK5VfG8fzDCLdBSuN7zU
cbvMltGTKt6rhh7JJyc6qvt7+ZN30O63ZZEAQw9ebeg4U0y4so9vkd0/ZgFIQjWOvpjF69GOma8E
VdFh9xxRAe4Mn/JSqPeIZWJb2edu9Shvyp3mrDGB3FIDzAzP9pBUMH1WpC32qv06wPB0zNwe29cS
LjmJvwq3hKdCUa5BYBOR8onZmi0gw28jAMGSsxqv0/tsvsmoNsP/5mG2yWRIBfmsjM9palPaKBdg
PXcyuFD4S5EbtTWY6LjclG54jJ90CIqt7LkF66DNRgEeJXhwx4qziD0KFF9OITivyw/qq+JSiuRa
905aSHBDoIhkTFueI8xetdBItmJ7Yb9f2Z7tgDKqxrItYRsM4t/pY+UmJ2EHNJqKYWuFPulCSYoH
9mnFLP3Z2YSDm0gGpgQbDznQ2TGD7hVSvwXMMjsZrDecq+ymnWYyX7UxQlGAsLvVuvPtSAHVoYhS
EDIBciDPrqaA68NB6fKCVnGsdhse8kP+gLXdIC2FUDZGe1W7Ue5XBkrfutcDpVbBMw22euSE5iGG
FzQJl0CzUC/w0kKB7iXbIbW9R5+aARGkz7+t3T78kYD6bW3mRuJmqEGCVKKOMm5SE4Rej5TvSDl0
22oTO9oDyL7MzmzQJifY1V1oFKuZZXpSbsZL2xmoSjxavGZvfznK81BMmwKJXlCx03yP7JT7auMD
5+jA7DYaCPcSOavLe3uI8CxBlhcLjOovxLjxYb9yMF2CIkMHZ6aPZwkc8GdwmuRbOQLeL3WyJ5RJ
t5k9GrHjAbq95j9uQVIUO44wEk2nSDcDK3RtPCvYlE3iFFJ5xzxEX8HgxPZ4Kp9FS77I5K34RqLL
hHyQqdroS1orDP1UBGeTjhIkBg8WCkgAzyuiCZvUmShga7dbyhQwnhGyk1iEwhGQI6zjbUYjM6MH
9enfI/Aw8F+W1ZnrmmJt8n1qWTqmh+TYWIAfmqfMGhoyoa2CHqr6vdtXJZHWXmQLC44HKQ/0MNrW
AWKZLXiSMl3NQ9AZMn7QDkcJPHsTzBbJzdV8FnVGs+lFuKOicQVoPzAB0C/5tbXiUJaTPOAKXdyP
W/9uPIQI8RjHd1JYa9ceJbeuEcoO/1ibB7NKDr2mgGELPXEDdD0UbmCFe7w1Ld+ebMmuVt/XCwEd
LII5GH1PKMmiEf16fCozKT0EJunRmYzxkKBb+bMyR8t7Cl4Za5V8n/7cfDpVUClgkBCLAPbs2pzf
RAnfJ20BtRyTQ+Mn3vDhA3uSPPp4d4s1jpjbvLQEfDuQg7hcAQrh5/YgW11nkKzBHrWEDWhnTVGH
nNSOeQDrU/+Cvgadv4dO2r6wPTOuSPyefsere2hhVX9/xA3OqpKHtJXhFwcfucfQZAEq22ToeAKj
hsjr5ZG5H0An0hgrN8LC3qVxBWQyWZUmqGcXLVpwyiSeYFdBtW3Tp2gze+VPiDFP3KE0oifWgRwB
bWpBvyK63LKSlLtVrN3aR8yivcDLMy5qsQKNxbmc5cVAKvNm/53qkICSHYo08FBlzh5Z6+y/19vH
lUmg195sx/2ehB8q4F8HeBSUAjpxsB+5UPuxubsQLTXDSY1JhXo9MpMZkqBPvOXdRU/yE0v6DX9o
dc14EOzUSFf3wsIBQKSHNDXg9gDFzxsNUzmr0yEdUe6+qx9r6JFAOMotTwyKwSfxUK8+yhfu5Ct7
MyeNWzNT+xz2mI16Hk12H26F3EieCrRWcU5kR9v4JOlr+FlhIeBCLQzCF6DBA+PGHMY6jVEnCS2Q
ZyD/EsHcwoHvCoGW+cEZyJpZ7dk3ha0CWhEkeFQSbSMHkb6ZbqCi6wy70cxsqLGaF94tLxk6v/7e
EwsPZ3zTP1+nzA5GkU6KnJb4OvlcBSa34wF56XQosefWaGUHz2SN779NLkUJVyapj/i1DUUpl4u6
h0nl8hyakwM+21deD44up9MWf4+kARHd0BJQ9f/b9OpoZydQmrSqLnmYbr+V++m5O74jDLOhzbI9
pfagx2s8ZwsPWkwvVMooMxd6/G6a6jiKORRjjNU3gntAxKOAJN+jWZpH9N0/9YZ/4ZCncaAmCBme
lQT9Twf47MCjfRJlf1xqKL/Pva2ieX5QyS0S9GYCAAnIhMwfnIPb8YCOS9ZzTzhLOYZEOzCkttsO
QONcfwlMARytKhl2nAmG4YNq9DnZNM8jFqV7nGyPnAvD2wfmioO6Ta8D7E1VclSIWiEJMH8lxJEf
AnKD740fkUaajOod/RN4fH21dgwuTidwpRNgAma7kQ//PgsK48C4gy6WdoMifrzelkIcMVUqAeeO
HqhX6GgO74NsSJWFqz8jwunvnXibzIc1dP+C4JvSwqBEf21NkeUsiPwOtaAKp12h6EyFdC/PuU15
U+TP3FYU9KCBVYlxJ30rfY6btS7+hchRViA9QyNHIO3m1AhiN2S830FpvXpOke4I8CqLtt7diOYg
c2W0Cz5QBRoApIMgtAJHyyx0DJPYb8PKQ+eCLurdpRdByUtGCLQ9hrvGEawUCaXsTgPdPQqjJ83R
7DZDn5tMIORbAwD09+csuYHfnzNvmJFzL84qRkv1zFVtGdUU34z33ga5hWAnbMPLKhBkIey5MjgL
Lf1+LIs8wvhDsP+CLw69Zudmo8DU8OiBFaOwP1eGeFOnkRA7/zPj8syvT33qCV0Mi73eQNGSgClh
G1kndOqiUMLbsfG3vSWnfmVvdrkGbd+raQl7jdG4gjt1ukZi1Nyzo6izbznYX6HOaBywxAHSOthr
/8G1X33A7EBlQZXLdf7zAfW+5i3sMdn68LdPuFQ9hbCQoQZz178dNYJJDc6Kugs8i+YUHGHUQso2
RkQ16pxRPaF0cveOk4zmfTyIAnjT0xY9G6cWYnNrtchbD0JFAHGWFPQEafBZM3/Faeha7ZWmwibm
XylzZ2h+vETozw9NcOVZoE0gGTzlQw/lsfO/VwSBdVCqonUFaX/8maVYRJUJJL5vK73G9QXyoQPo
eWAWpUd/3+nCo4CzjKbd9H4Trzb73b7UUPtCHgldUGjEoi07187T7+WBEfK60vk9qMvAKqw6sf6U
P+dObK35rmVjFEUCGjq0Ys8BTYPgtWLYYJ4Z5EOnjabTSCF1JhP1pM2qa7p5I9Ch/bI228ZBoviT
rGFopSlv/S1DgmNihCGRjy/iLotWju0tyHVmbraJ0PFSchyKunjzVkYBhAIUJpQELT/IGOl/H5bb
8tTMlny9ajIXAajYwla/bc33YRfb6At4pthxxhqOq9mgmztnZm62QzmxBYcVHVrz3Jrjm7LrQOYE
2JkIYg//0tjVw3n1TN5UUmc2Z8lVZJ/UnsthUz2nm8CgtbBRD1wI5ggp6AoaUHQONuIr1srsteDp
xuNT2yIojmn9C2IcMw/co5OsHivY5j60z/jN8vY8io6tNSB9vc2d1eW8eU3O7M12qhS2bFzQ5RT3
DIBFPUIVyoNWgr8dOS9Kj9noyV7VM/vvfXQTtszszrZs049aypSwC84xS43I+51ks/+P/oPl8dHg
HV1SUGiY7Z8EkkcBp3XwcFvebr/SPVhBgGZLQXBUmd1b6LwF23aHLqm/h3cbnPyM7x+7sz2kZYIQ
iRFaVSj3hExVGT23eq9MDqChLCEP57W+dGHR56AWwMmgrML2ma1kNwHDmoXw5TQ609zaPHLOqB/v
nj2oBtC+GuXAO/vw4Usm4wsYEIhv2cEuBPumdv+wmkulbuDq0YLxQ2qZ4omALJLmopRMHnF5nIkV
aMjR6BpuJsSlIpHOaOXOe5QAS5cFUc10atk1B7V0etHdgj4xMAMgETjbWYGIElA9shXK2Z26KU6I
CnVTPqJIwa5EK4tj/GWJ/v/XEzhkoYmRDrBUmh3U1vHWyrSV0dxGZHQeERIBWE8J336Qgr9sxGoq
1p4iw/99DNDAxBPDVgDukB3VBbPnhPJHQA49ycH4oDj8Soi9bB0BggSfhO7sefoWWldp2Q5YxXHL
p0Yn6AUecDpnYwff9TZ4NSQSMCbMmwFlO9fQWmys9mbdFoLoHAB6DQAmj0axOcdRm4UBF+do4pX3
9Zt656cAvofIcIwfioXm7TdhIsJrZfr3LLBqxUdoad3KMizdelDAhDY63VRU5/N6qQveR16yDWs9
RX7eKo5o7LWkPfvZoAJVgD6J1/7DnX5lcba5FH5stTqDxZ9XPyhG+5MGLGgDGrZqrfpw2xRGFX5/
DW/2skuLQQbxQgAVdls+B0ZrRgaTgGz8MtrK54pnXDifYMvigOVFJhszOrvhprRO2ApqjbjhMB6I
q6QEe3lAi528n15WjC04RTxVAR+GKZTx5vCOIZTLwgfnMR5L2pE1J9AFgrEQgjxvEYlsHN0Ve9St
z9zelb3ZdRN7YjYJfArIDoDRZ9GmzOIWehSQnjJajTSmcKYXT0FyN/yW7lesUxf/l/XZpTP4fSlP
Gay3ek4fEIf3zmJRfFcN9pJ/VnrwtWJw4RZHRhSMN+CbAuBgrsrAM3w5MXwOZew9gN/9VrYl83g6
oh5QbCByZidki1bgFqmI/9DISGWIf9meHZCpqhS+0WA7P3cE9QDdO8Z2Z363ClkriS6t6m9Ts1WF
yD2f9EFRgzk9c4Njs2H2zHmt6Lvk5jAgCMuyyDCi5XdmpVEaHmDnklqZwGTTgFYGtXwwvTjV/5F2
Xb1168z2FwlQL6+qu3gX9/IixHai3rt+/V30xTnRpoVNfD4IkAQxkBHJ4ZCcWbPW5jV0ixfjID6E
d9M+xmUmeU8mhvN+5zH7mtG/H0BFgTqbu9HgyQcAEzvdqsAm6d4IkSf+E+Ars3ZCF9B34FOFHShx
XQ3aQqE3ngzzCYT9DsO1yGhpX0aCWUNJASQCSLNdRtykjqo54muAV3B5QdxFRq07hgi8AeEykDeR
3YFMkPdYa732UgSN4F/D1CbKOYhfNSMMo/tl3vI43HnApgiHFTZwVP5A3YJM+1+DNANLHzQxBN9h
8C3YNZX5OzdFrPsMHOVk88h3gLmJMbdrIXhpkcSRxaVCGausUwRYjG94q/vtP6R77g00O0eJVa/8
DsqiBkft0lRF/6XSktl0wy1Qv7vczjwDWCgMLkFrNaQ0NuKzfHd9hF/P+e/eg44p8OGhVkqX8hXU
CVtVgysb9+pO20vPYINAg/kZPYiYW94trWe4spXiPs5veFt4ZZUJV28McF2kN5AvBUqHOuZCY0z5
TsfAVQ9JACv+DIGrPkZnzk4ddJ9uWTDO1TN8aZBa1C7WwXuPyghpw0RadjCfX0WzuZ82BcjefzK9
i8FR16GmwpW19mGrcHjfUdEXl5g8CtGg3XwmfE2k+HP2zx/lXeC0eKknqEvz/3spEIBV3AoBuIKI
BrCG1E4d/VCABs6M26nne9mf2W337zPup5oDXPl9cC49OcC14vrYv3fkwaqikCUF8ycQFHTaKtdm
X0ikGojRApQ2TnYYvBEOrZg5BNjQuc8j5409yyL8+A6MIYbBqoIiEPh6v2G+pCoZmz7HU0ATrXFf
7YQ7zoocdQsSz/m22/a7DIIG46vwyRK9WtvEQJHqBng1eR4lMHLLWsSLsS4I/clELuCjG0NrLtik
2MZya/kb+R6QpF0o4zrVMV/RxI+obQwwtAF+FQBKMd+Un8l4X0XTLOAVbWugr7RPjRdpjilKTnnw
HR1hmRAjM6/DK/coIKGREQWNLXKT9KNLV8dW91OYle5B3pe62otk2P59487WtMXNzW0mm+FVK8cd
FBzAWghhUKL5TsXJYhb4xOBwIeW95o7w8qCjGCdvbsob/walXJu3+T1eeIxAuerNuLECTwZWOcCP
qKgxzajqZ+1I8j/zC3Du0nuMTN4x2rXP6ra9Le/UwBR+M2EzKxdHtDcBM6mJCulEoU53KPIO2lRq
yCIejOMAVv3nZFNuokO9Sx8Fq4Gq1zY4+47/2+g2yTszOH8DLWArLc1TkUNqwoY3iPneLY7ovQE3
Y/6OQxBAxmYTFqyLFYn1l24sQQ8E1zq8oAn7GHWxmgZhHrNeavCM5nAvF/F7g8uVdBR3hot7XuE1
Eg6lGDjhnbZFSqaxkJhhBZCvwuu3zwBMyQBMlUcOnJp0tef1lkvwn/PoXq0s5BBcyevxKeAq2nSA
ZIUgc0+8HAGbg4qGsuXBBSsffuBzwNkDJ0voyPAtMvUd8jT7Az/qjRU81R+qI6C74qR6KLv81px8
E4OHW9hNDLrmlfP40ii15JFigBKbGG0/JjQJaua8qW8inFiNC1be47RhbOjvoevCHk3W2JUiEQqE
vadyq0NuPbvlTAEJzptnAwXD9iAcbq9b/L6lLg1SQXrKCuiVpjCo3UvPLVomQHz8kLNlQr5fHi/t
UBebkZ/buJtgJ97WgAHf9OiXcEG68AAvcort5KJapTv51+vPj1xWZnHllXJpn4pYgRr4ckMWcnB8
ZOXlY+vGr5mDiLUfIWdFrhsavJjfRtvjn/EsnkQIp0XvPpaYlXNdyY9dfgt1PhV8Hkt+i28JnjoH
mWVwcKMjCtppIF2N35uX8onz4uN9eBis2GNxf6xcCC6tU2eGoUyKkpCVmHaq43t6ahpAGgnopiRt
8fpH8srd6htmZoo4EhVG0C6KywDe/UhIGlQ047Jx4sQWYUR9y+0WNBun+lk4lk62LT4r3OtZ5dnv
wRpstrhnCTinUKSkr3mTIVackhnksjm+aNBRypx9i0u1bM2gqST0E74LLoRHhFNzKsx6lzPSoGsT
vfgC1BAv7z/GUEljMuMLuA1A5pVzyJz2HV0NXgrK9eLDf2jOw3P9xmykWTk3YBdFaQnIZCRhqUCp
aHJX5xwWGLXZN2ikQWvoDTqbwfa+Av/qJkss5slI/kt6cZcmqTApBfM8JD6Gylv9VtgEna2e+xZI
e8HiXlVQDsQ78cid+Q2Tz5d463fL6EEGiAUUivSDSVTKKZRaH9kHb7wRH4EjjG2wx2xwHHlILoOI
4L72hv3T/xw1McV/rVI7eNb7cYoDrkFXah6a/T7+g/5fNIuYwud1Qyt5BeLGfy1RuzXP1SaJZIwv
Ayz32L7kyGFzToGmO4jEth6TZ5TEwWvzSa1krfulJvSwB3m5o4LnWeW89FAE2Pr3vPur2TCVTFYO
hosBUnFBVseo7zUYlD7AFJAdZt4SB7N7aR6CmSmut1LzBu8hnl/oU8A18ltBH/hDVKIrLNyU2u1L
44mvuD4c9JMClBVj5dY8U0OPJC6qBKtA17Kga1YZcxa0YB0M7qT73gaovL2JX6C2eyfLTgf1wPYX
qJVYVwiWXcpjolyVkiCBXeEjccKn3I6guSyC1FsDpM0Sj/Ibkq68R9rkfzJioNnBAEJY6QzqjRuq
YqdPqYYzdlfeCJ8NpDERgvhHwMuC3zfcYf6VggFaYnF9rF3SgHPEsqJ7EHUWGmWbx9XAg+QaLnQa
3dCqAKc78mdIKX1UrrHtNkwJ25U6LdwI+Dk0aEPfGuStl6GdS5VeHiponHa/9M6pemfcgTdT8tJd
BMpy1LJAgANubemVMcNroX1pl1pbIa9jQa2J3d3gaSfuDsfboeis9tA6rdW+sgRAV97wGCjhEwFU
G7hMGqct1cKg8V3UWsbHJJvGc3gv3GWHhEj0jdYAvlAOZSx+X9i8ZjLGunIVJmz8aMYApwy6Uak5
5uOwGeoKphsN7D38zs8BY5ud6Qxeso1+nx6k0sxOzGfG2r0BpGQApSOtjrYJKh5JRV4lyowpbkHV
iTyy6d8H29fwYLBFaEgspWPtwpRMXRDiQTcCf8YIS6BUkPA7Ku/J7+IwncCVPrmyq5wTl38LXkM2
imrVkf6O8tu6ToNUdGSUpE0KWU6ISmjHfPP66FvFnr2WqzFpYY56ZQj93KZQJMSkojtKgJSbFR0g
o2RJd0RlWrtJD9kPKPeJ/jyyuCiBo90RWYrLTSrWIzDFYtyipA+KaggjbxRztMf9IICYFK945a2D
fggIlm/HM8N31+5DS9PUa6McjTSHqEWLW4nyITp5gSxUQqTHT+jOM24h9e4FQJH5Ts4MhisHOKIv
kfBA8gsJBGrbCGI4iKMA09MOVwb/ILgNiBZw0p1Rfld28ia9jb3rw/0CLFOODJvonIJcLXAbNCbP
EMZE6CPYbB9IEbhAz3KJm18AkUvcPx3SQjI6mYsqyE494gc3oTnspTO7zYNszmsfQvlZlQCCNaT4
EOWUWk/JPg3NTLXE1tahVwOk5uYX9Gork3vIH6VtyGIeW4lYF9NArXox1okxFGQaXAjzgujgpRmt
fhPbxp1w1zqhqSHlbF2f+++4eR3wRIALgHYAUTrovC+9PNLLBBJaKVxtl98ccN725/gMIY0H+Dio
v0yw8bvdJ2ffxnju/cC2gD0GESMQ0+sKdRwNas6L8ZS1VlVDyj3ZoI3gTwRhyOym3uSbXLfO4r1O
sq1gwdtMd9etf5X86cUmVZKvixz6bKlInWlTEExhi/dVboYWv1N3Kra6OkFAlxBKJ1vlMLjHePd6
hkoceIjvIUBup3vFq9wcXItgFmeSBK0Ac4FP+PtNdEgv+aGuJbVB4er0wjnBTgJ3aHGbPqO1DnwN
8TPYa53bhDeVc7UPbMDt0fF2fVrW7iZffItEvg2N9PRmTOoylzID2mXggJJ3EsiRQ8K21iPPAqag
s2SKuPtdt7mW0biwSe27KfX7WtVh8z0AJfDN+MyfpzP/UtmvoEEBDBIR1w538h6zvmEyia4cLhfG
qR0wGFJsGHlPEhqkz6Vw/MlKPA6CTQNkVQQzAoevzsworW48wmv5zzxTuz0Ai4VfJjDLbWZopylm
sUsSVHybj5vqQT5BKc1WDxoy8CKz2rwacJe2qSDfTrjxThLmWzoJ7oxKOi6+73cqEJ+qLez4M38y
LMmTwRSRPN9DpNX8AV0H4s7yE6i93+dtPag+PkE8SAJcrHXuZnN0Oetr6+Vu9lJ62k4CbcR1X1uf
d4hTQfhShUw3/eIfe3lqgh7zDvo2uFaDuNqZ/YsEbhQNeZ1yH0OkAC9/EIr61s+OGAhjoQQB0wQx
eBlvhTwd4ogfv7Irgl1tJoS+d8z6/iN/Ks3fqEA8TCaI5q30SWfWLtfON2iCoekAgk0GAEqXxtW+
rpNqhnGJcAsZJsq2p+wX9AIs5Ranew1eo94qXmuodxPR9C1j6tcOuKV5yuWHKooydSRjBwXJx/iS
HGJ0DZdWAJUECBclv4hIfXb6vG52NahqEIQgvCAEzEjlJLRIGkDgj0JIDY712x6ZSu2Ug1a03Cab
ATQ/EkrkSoIIhy5qNNXEDjhCwkeZSVLyPdCA2QBMslBNkECgSddwu6YQgaxEKVVERHtx+fsRwlUF
PE61jQQQ7+ElsLp30KBdH//XQXZ50F3apaKr0ESJPqlYXc180HfpzXxunPnUu7fgksK/dZDF6PDP
GkjwzQfFwZ3jufE4QB0Vp3baTfwkWEDa4wwsbgrs0+GZSbpBvuDaF1J+qRdF3ZUS+cJT6IUP4OOD
XJ8Ovit8wb4EJBBcCDvdFO8gZhKCmK5nnXpfVSj6C5DSwUUfQiaEpO9yZ8jJ1JWDCOCjdjqprwDe
e7UNig2zBhrKavelYqLEvi2sD1xCzT/QkePdxObcFPGJBR9c8VcZhbu/30L5axoEAEUK+BbUn5HW
B4Tj95sBaQL/E2ESsQm3X/ypmjUh3lS2HDtBsQLrvvgEut27UPsqThV8AgrDGTqBRIiyq9v32s7e
FVP6nECJUj77HOkcQh0efCiAtQyv0t0H+rDdYptag53YrIbjrw1yZZEMypHlGRsr4fFV4iG6Q2fz
G8jJkp1vf+Rm5ImnAkXM5wH16snFk5e1jVYuKZdzQjlpFjaF0ZNl0b33Dj64Ce9RQ55vgZx6ndFZ
Gt8iZaPdaCf/qJFFYrEyfw/eQAZIINpDvV5DaoNy0Vkwkq4aQlCFcTdyO9nSlLygH+gx5tI3wcfE
p2hPaZnlgO8JVpjFy4xQapDQRV2TlaTjq1IFcrasN75kJoLXQ/IWpF6ipc4AnCCaAvlzPWR9Pyhg
k5ToeRRrESqpEoTcTVwuEmSwId0pol1nE6I04zRatUHYM5DGxS+eWs4xq2ajKDGuVA32leiJfbkp
y9/XB7KCj8JIFlaoIy9u9TptB1iJCLHqhD6EIrmr/PHUyLol+HWPxHxty0QeslYe0JfHAj18TyVc
fgCZhgWKxi+RYi4yeG2bTC8qGnrGOfrgpHLDd5VZtwVj5dbOuOV4KSdVMqEfeh/jzUOv7Z+i8bmN
nnpmXvF76ouMikhPGehfRF2QGlUWZkLRJXgndcnnzOufmTg5oGw2pSa46eWPHi/KqANGqZOinSwC
7J2BND2vGugRqGEM3rvPUhcOEbrj5DZnKJIyPk6n8nK5prZR4GPKh9msov2se6BFMxTUrnkoYLPA
jut+DLQqIoIG8UnKj0WjbfyATEWuT2aZo5eUK7ZynjOgDKvRB7fWf8xQjjzKwgCoFMzE/XNbnroZ
l2fZ1VPdmtDKOFta3DjX9w5rYJTnTq3gV2EPi3w2W60OnSt9EqyiHSuGz7IMUT4bhGopCw2ZQe0x
UY4AtJtlzIJ3rc4fqkZ41gkkm0h5rKwlZSQ0QMn7YNRukuchPgZTbDf+rznyFFSwG5VFIr26F9HF
o0O2ALxWNClRWnad6hOcfKS4eqV7QwOV+cPUCe4PFkpH2QZtYOA11qiFStpJnIsEdpRmsmZ5G86C
03GJc93KaiBbWKFWKdPlWovRxwFK9PImb6bUDVruVWuBxxPF7rYIYlZ+imWROoUKyRf7scwBOeh8
t+heKwUYeB4Xni7YiXGyvT6+1aixGB9160PPdKx2Faz11ZYTHuN6pwzh7VwPdgGVV0mPvOv2WKOj
HDLP5j6OathLm9HNNOlcqo0p66kTtfFxLMSUscvWvfFfL6Gjot6KqaZF8JJeAIJzfKibP5X2OXJ3
14e1fuL+nUeauAQYyiguc9hpDfGtSUCaUsc5t4ca+I2YZWjaGEfVycG+avFlBkiF2P/h2pJFasAa
rXh5QDURYpVARltzrqjbJdCzXQoZAY2Vz1hdRjTLYd8BGQyOpktDhqhmojFhGcPykFXumNwKJfK2
9XPob67P7KqDLixRJ8DAaUY+j7BkiE8tj3l0c2QR8trsEt0ETcVP/IX0lBKOE7RzUlFF5oa0jXqy
jhUsRYKdQdiwncWDmg6MyvPqYi1MUaElrpOSL0EKYAG7cK+Lw2usTFY+qNtaMRijWj1rFqaomNLE
XA6hMEyiHKCOY6homu/eZZ2pRva9DIkL0sIOFU1iGfK6X81DOSiiZjvHS0UMSzuHb1TpQwu5nPY8
65bS2tedhDWVVFRJtHDsihpTWUmy2YpGYaY1qHCh1zLkCiukrOCIySjRfEzarMlfL52/yooSwpyw
psTj7xQ1I14MTvoYbNssevHzDL3kTfcnhl5SYqCHSoeOSNzYceXbEOV9lpGKuT56Yo9+oC6+hyaH
6TktL4cOLVs5UkgCcNW6DCquUHWUwuVUOzUcsFf9YMZBOKiADhAwX1miPIorUkUa8xo2efQ4Qzjb
kYvJnktQaYsyI1G/gn+R+aUxyq3SniuAXUKHS1btpX7Pq5Yc3QyZXWiPoKdJUeCPWLeYlYTtpU1q
kfFOayFxTxrEhF0enbIWE1nabXyfSKba2XJxCPhNEjuoXfntYdI3wrAL2zstcmp1HwWsPMDaDl5M
AV2i4bhJCqUUn9MowduQNJ+qmHjl6DOqgSSa0q6EFBD4PKDRCIYWKvwJZVBIUQEzsdZ5o5q/Cvp8
e91b146OpQkq7BmBhAQ88MKWHDdmI+8bHP4zdxaSJ5//9d9MUU6qGq2utQI2Rt0IZpjdNlzlltpe
4XKrKRgzt75Af2eO8tG2Cf0shcC3hUBk8eAg4IDQlBnPoXUjRKIH4stoKaAGlIyGHjUcdl3SoFsy
Dq0s8PellDOWaO3MVUER9I8Zaix1lBZ+NZN6YH4Y6weVa16a/FikratCcDkEuQ/jfFq9Pi0tUrtt
luScj1tY7PLRCouN8RuDk45Tae4izponq+tz9wfOgY4MIDD/vzn7Moq3uIe2Hel95AMA3NCzy2mD
k7ZHQ3hoJRYZ/uq+WhgjP1/kQ8o0yAMkNvEoKiVnHCJ4I2eB/9/yS7cPBFPoHVl4KozbqkaK5KkD
hz3rvbQ+x4tvoPZ2kM/paNQYsKqahv82yndhggPZkTmcYKXjD7Wpy6dGe70+z0y71IYvNS3UhgZ2
6zkxoSTI97cFKOREt4TKF5dmZqmi0CvbAm4G102vbpfFiKntkmc9F+cTLJedk/LQAFBHr2e9aNaX
lugm4eIEXXJyJ1osLTfMfMEFpKQ483bTQs1HaruX6wNZAQviNIJcxD9GqIv9YNStZoxADQjGCTLB
rfhsGF7N3WTysY8gbfNsiF7THvXio2XRcqwGg4Vp6qrPVYnM9Uj3WBLgGp3Cm3P0wIWAsdW8pUIK
kNMURjRYu88gdQAcOOCR2jeIhFLmMR/MBCJRPkz9oTVMLXL9EoAMCcLE7UYvHMb0rmWbFxbp07XX
xbSZcljsNa8VHbU4T8ls+j30/sLWlPDaaEqTT1k48FX/BMMvwO2kdZd+bEiCgXq8ArMG/5RHtRPx
QL4E/YYxulUPXZihNuDYGsmgFqg969xH25mVdoMQbup+ZXHg3wa/d63dg+qOjx0xfAuq0VQKjXE6
EhPf7hWLT6B24iiFaRqHpPxdZTYfKm4i303yeK47xtG1PqUGNFplELt/S3jFtQ4JtRE1vYK7acbb
xD/kwfb6fK5P578maFrqoMuroutgospRM9dKe0h/khuEmsk/o6Db5DPBh1wwGYWCDsU6Kexg2odM
RotVr4fCAVhmQI6uy9TO5gMhjTgdVtIkfMXfPaHWN7VWOrE/H3JF8gb1NoeIDt4SBeNAXA0qC9PU
eQhR2WyOeryEUuGpHEPTSHtziLpt579Kw1tTzYw9sBpSFvaI2yyCdBUKSjz0ZEKN2ZPm0RMH3ikL
0cyM/hRUqkfqElEq2NddhTVMaudlYz9KPDErGtwT57/3aRWarTS5hfQm9JkziCUjqbD6OIUcCmhp
UWNCVZla1C6UM6OdMbORCF1gcXwU5vIQCaWn64ByCY+RMG3GAJ+hTSB48KGpbBrcMxpyTb2BOrU6
uNenYHW3QGGBB/oACjl0B5U8RlMXKzpayKvRS8XubgxZNTUSPL4Fl39NgKH2cnH7Em/8OYQJ4EsG
5Yj3YJx4uuxK40+i2MIQfdR3ipYZI0C4vupbkQ8VozY0y2Te5CEr77waxxamqANf1NMi4sky9u2m
V2/14bkVWOfs+rt6YYTylVxtZ35qMR4tC5AglcwByKME7QB+a8W502qOSDIKDatcxzRMbf/cB6t/
KJCeZB4agH5gzuhylzc98E/1aE7qRqqOlfaTo2ExWioG6H2R6DEHo7loa5xs+oGnNT3j7rK6bl9y
j0iKAiZPGZHyNBt1sm55om/GCLQMk+pogmRd31WrLr8wQwWWSlQnPVZhBtIQZle+1wVo9whFQ+z6
/sgwtnp4L4xRhzfE3rWinmCsmnJzSo8lGOCm4FdTzIxwyTJEwukiSquBUOPZCUNRfo4HD6x6poZK
X8SolLLWiBwWCzNKiQMgieEIPLp+siC7D/nJzarm/voarZsBZSfowVEgpSGt4E8OM3RFg95SgmyB
NKE0cD+Kwo8c7q8VKlDkSVkHqEuAArBVNoIRPkxV5MW5wcg8rJ5koDb8ZzBUqOgiLQ063UCMRSpl
Dj3Zzx0l2rR4oVeBPbMSAqy5owKEXvuD3BUwFxTHUAQVXw/JXRa0hTUmaq8i/xUa6oipy5DstWtA
PwDFm7NfUaqDbJBPkJ+qskFypHTuHq77xvqjGEcVuvogSAhKkUsflDsubIfBB9tH6yhQxeucNgTG
qTiWxc5obchPdwATBCNrzGTivp2Vf+1+wY0Wvp8HczX1CcY8C+hmBlTBH1k3kNVr5cIEdUpOPdem
qQATEDS2OYyi1DYqAq0YW8mYWBPgvpBWD1gKVqyRURtByyHmlPZwGYXTtmPZPc116l1ftVWvXIyM
2gSKGnUN32DRjOJQZznQNQ8avPO6kdWr6sII5fqgs9C5acI4kNU3ZW7bIArWomQ2WDB1hAz6buY2
102ypo7aCOnAZ3knwmTu+0iqpzvovrxdN7Ea2hejog4sVfJRhtURcyvAfPP6kPuF16mHCLodPzEk
gWZclBQJ3ZWXGytWw8GXJQ4kL9pwFrI4sMQczY0jdCJ0+fm6rdVTGDwy/9iilqqumrRVDfhDpuyR
NhiF2pZaW0JbB/h0rpta94q/pqglalLAYPISpgSpu5GCyYrluzEDAQPfBe99nW7Rze4MpS8ypnPd
5f/apdZN5hPowiaYThExvgNBnxo8BuPAqPCsRuLFRFI3DAkdSL5ERqfLdpvelXIE1BpEHRW3rA0n
CN3rk7nujH8HRT5nEQTnru8MIcOg0sDpUSHrS09q3mSVBR1l2aGCvJAOvV7xGJYIpM1I3n5VhKpc
ct8VMSvqkqj6PbD/MyYwgF6OKde5zI902DLCx2jYgoxTSsBZ2FnzAOW85H42/oz8QyG3jNixQhiB
1OS/a4d220vDI6em6pzBcNSAezP+0/hG4Oojb7a4kFQJ52Xlfd9PptFDlQVPzrL3XbGHoqIETYVe
uxvl6jxlPKvkfd2lwKZ7+Vl5q8lNn2KN2/ix7feKftsW4S5On1T1LalVxjZZ357gDRMgNAf1WSrq
SMJUQswXZ16d8iBOtPoC7etSA4Wo7Zj/mgC+MkJGRFh1Lg0dbJqADA6eGpcDHBNfFKMaQRuZS1ML
naZ9baTflcp4866nnhd2yHcsNgvXTXHc+BiaVm3LfJtFoKz6SOtN1t9OgieIOGs/6+6xSm8n2bev
b9TVRVzYpuKCrFdiq5IzXao2qQosOmR2UNTvdLcLbL4b/uOUUnEBIk9CLLQwF2S/q+gol1YFLWiF
MajV03YxKCoqNEaspqUEK30ybxWl+xQ6kXFbv+4bqORerlnKx0aZRzARVWhhQ1zjkOTlzmnlXl+f
1dMB3AXgrOah6SFSPqgbvdjGWYDax1gcOFk6qBn/pNba3XUz67flhR3KB9uwTDpfQoyRhmdUBwXJ
iaG2JYCIMHD42uYgr+SbYcczdvW67y/sUv4nTlzTdDPs1kCp1X2182fJxOPR9nMoESZgiTV+NXn4
UcagYqrQNtE1N5oGvPX18a8u5+IzKL+U/DmXhpbEsrTblXK5b4CTy0Y08nAzw9TqlWZhinLOzFDK
Aa8vaBVknwocp47xuCvdZngGXePmPw2LZlxPmsTPJfKmDGo3CCMLtozJ4mXG1XM1iEAjS4VkMdr/
dGoRZXlUY22Ak1aTJze/AX4qi8yOeFtpH2u+Yezu1ZNgYY1aK6PTklYbsVb88CbWj2q/F42nwQ8B
893npTu1HWMPsgxSK5Y0PicXBRleHpsBtKG4g1CLZl0cM8lRVEdipYNW49ffEdJdOkoYAmwsok0C
JQVzQqZhjtuH656xjr5Z2KAuFX4DBFU+YlB8yt8a0YCmwbTozSITQf2QjsdqiE9823zU0gAQuDw/
Nv685UhJq45OUS2EVl2nsVOkkm/lPapdUOnOzNjwOcaRsR4B/3UuujnIB2OrElb40JifdxyqGGkp
H4MKkkrXZ4Rlh7pggNUlLmMNboWc4kbyC6fSGhOCEAwz63tFI1lSlF9Bn0gdHKpcALeG4WjqY6/O
ZpPZXQvOC1Ctjbe8ylQxX721ggEAnA9gAgBn5KW9YNBGP5HhS2lipdpkFt1NhiLvGD6MIJLLNwZA
yBzaRXJW692qEy8Mk58vbjVBZHBpQVrNJq3yuHHwBlYLzGrQXligzsY0zBQc7JjKEWR1+eyWqm8n
2qaQWZwzqyH7q8kUE6jj0Xs5FC2OjbEY4Bp5eKdUTgREBY87kuxEPesgWvXChSlq1vxR7Pk8J6aq
W7RmmGrDm1kQMyIaywo1c1kQgiOAvDm56MZA5T8CnDNnNXuthk2gl8FUChb4b0DfcAAYDG07QFQI
SJ1HN1NsFaBtlpqTkTpxAp5UiXEOrdASyaAiRT8bkTgB2y61ucq0T7JEg8k2N5ODcjed1YfmKJ59
F4S3L2DPwRVjG/zBFeN67Fjb1Au79Dkr1kkeC18pkXmrgzAayNj4LAb7TrCn+Pa6rdVuyaUxKnKD
yCvpcS0jPZyGCQn7AHJAYC801XO2y7xyb8wmhHrTx8oN7AT6xT6IVa5/wtp+WH6BeLkfUNKUIlWG
+8yj28X7aUKO5EGvbVX4dd3QahlraYnaeSBqzMUhgCUx3iMkd1NnS/xeUQAdkTa16lagcalYyYvv
Cq04F5dWqU2o630g9hxmuDGLw4xL5z0fm2NgIhUfPreP/t2+JR3tkf3LdwJWrVViORO1OcU5ifge
LFdQSwxd/0E9x8+NrTkRKConL8CC3sa2bstWvVXuKpt7Q8vw1gM7KLy7tJoNDnEwhoNPdSO91i5/
y+0j1q19LbRr6OAEtQ/U0WWacjdVpzmJMzQDauPRj0ZrYh5bawFKg8oW6X9QBCgvXXpYnWdtyk84
PHLfVCaA2DLPZ3YirD4+llaoda7RCY3eY1hBoysPknUtPUDrVQ4/pQ6V/ZRzDcGp+MeZ9wbDVSbe
YXg32Sd0Rmlpn1rp1OdaPtNgP5WAAW0CjwcATEmLciPGPKDYyS7sW08uE6vEK5OLhy2QRj8pby0/
gpyyi3NaRqUT+Eh8hFDcDhyInIFSzHJW4XH1gbk0Q78R2oyTsgRejSd5rbtNczMPTyqnor35pYkf
+WKjVNtqvrs+xWtXhKVV6q3AlSNg5aRLVq64XTJr+yH9wwnpczNxn9ctsTyWOnrqni/yXMf4tOms
CI9Tf9/6f/6TCfpZEHdpl2sBBiMmsyVGouVLszunuX3dDGupaL7GWTdCpRvIpMkuhxc5rjudvq3F
U684g/AZC/tCsHk12163y5hB+qIfhGMv8CHMBspLjbpZL9wq4vN1G+ux9d+4Qt+GFT1uyqzEKkUD
MKt9hXQH96Lrw75WxPdYv2/0aHPd4nqs/GuRijGTkdSp7MNiXR18HhdtEIWwblqrNgBuBB8jKNC/
IZLyRm/QxUscowuPhTEgPWLIRfdxfSSrcyd8qQkB56XQc8cDATSkhEpDrFR74syJP/jpZIucZFfq
KUC17r/Zo2YuC+YpiUmLfVLd1fLJT9xkuon118y/HdWacYNbdb7F4KhQrPFRnPCEDWHqZ+Dvt3XS
mGHCwOStRqOFESrUJkE/oOQNI/5QOej6tvjIwPtbPwHowXA71mJR4VYN8lhMeJgqgPI3AFlx2vl9
Gu8lcc+1jNrS6tyJhOdNA8XKt9S81jZTmfq4LkHQXpmGnQD2kIrFT75+7V1Yodwhl8WSA4wSGNtD
eKo38wbVq212KEHTEZso3EKjzJa2ucUdMpfPTMiMOiJj/VaEgHAxXHwD5SVtJ3NynWAL9B8nCffu
J2D6Pl8eRAWkNpXdW4qnQZp+eoYcvSXtZgWMfzLjG1bhh8tvoJwIudExawLMQwc+KzsbLOVu3Dce
+ATfq4/wVnKSEtRXleBc343rl+LF2CmPSnNxUpsKdkGZqXOQ8R737Ub89D/BmYLaEu+KZvWOKukJ
pOaS5vyARfhy7onHL+4pviwniRHBvnJ/MDJcxP2bAXjqGJYnU7/r9v6dePRnM3i/PvDVTbsYN3Ww
x2pTKiqRToxBl4YsDaRNOKdhFYEYVr4eQovRaQnaHoDhxsFUv8f+XkmtJO7NuWK8kMnHfrtx/h3M
19G/MCMqjQ9WPDKJQWalofZbwkvGEEKTl/7MIY/HFY+8LQsyuxqMFlbJPXhhFSqGddhPsNqVn5wv
22my8aE3OukPKvKGUeNeX7FVoqXFFvm69y/sBWVmcB3Jn05WZWkaXsfaC/5An6x2VBroJr7y763F
33E3udc+yrGV3nI3k3f9KxhR8YuPcfERLWjyELHgN5WAvTIIbiFbkGL6ybm1mFoqIhUgvu5D4jdV
nZu+WlkK5DoS1pWQtYBUzEnrnMAUYIWPPxrBaTq7Cj+UxJmSyoyZAuRrKcvl8lGRRuHG+v9Iu7Ld
unVl+UUCJEoUpVcNa/Ds2PGQFyF2Es3zrK+/JeOebS2aZxE7B3mLgVUi2Ww2m91VOVu9rDK0zszQ
zHynMi8eeq9vvQiJN1rtWPeEFlCJj5MtGediSF+r0IbAMLt+j4TDlP1GKbVkwWRTybkTlKaXkMEF
hk2ccXkZ82O+7C3U+kGAcreYkkyNZL/zxWh0buJ+WBcut3yl92MoPxXYgslxIYM725eTIrF62TH9
8feN2VcWbD5usHjZEeXb5AISt9VVd2n7mRNft7vEaXX327z7nu2Hi9GhkG0+v+2EsfDnhvjwDRt8
dB8EeMvEiJW080PGkAqUuJfV/L76UEpskPeDeJAn5hl6heoGQWhllU99dGT2ZVc/RZnPdMlQZEBc
xEMnpS7zlXOpmnd1BDqkC7RuZqPX/1UZDQgZ/hkS50XMYcyjCd3Crlq+o9kckWmGt9ZS1sErXhuL
4YUQvMRoPDs9B+ZEV7XMXLmGUOKaWymKkY7nV1+8uz4RuB08qxFZLBPWt2iJM8c1TpfSDZhxNZSK
k4XUa0cmOVI/sv9f7eETk9vR1vpcV6/sdXFRP6eE4YqXFdD5tLP8wNrKwAEb5oSCazWdX+PeyNEl
VjeXeY5mc6eIFf2N9Ev73k9oqGoMa7pSx6n6YXRR9g3dlQbIrEA/5KASID7kS4vK1QqtZHXfWX9Q
Vhg89bM6v0G7EnJb9QRq11RXbHfuUI+QmmF4CDsW7PKO6ojaKju9ZkM4XLN5Do/ohQMpZtddt11M
V7EbY/JqW4/fB2uGylRq08PCWuN3pNYJtDfSHLkhhfqJPj2oFcv3aU0f9EmxD0ZJwOeoxHelHSuS
BRUnI2Aw/28zPL3MHCwMpQGYXRBeKCj2nxYnT3occy81pBGVq6X8jrcze5ARaIvPgk9cLstezJFG
UES2ZiAXcKIoTpCZbvp3x/cnChcZKSwrQLGEHVGD5oz2bjDsouD3+T0hnkId7G0q5BJWBp3TbRfW
tpEWM0D65CFc9ur4faH7FEEf+jPyeKe0b81a0fY3B90GlYsZjFXJuZmAGrQ/4/op1hLQ4V0qw1FP
H1IqS4EIl2uDxrmWjMUUnNdAU5TXWH830G21MP9/nEjeu0xlEgY2QJLqPuhviX0zqaXTlxdz5LXI
zBelO+LNpZI9gQsPAt1eOQ1BBwKasdMFrCI7y5YOFFmsCfbLNLl5HN30Y3jTsPkna/O/OeA2cNzK
gaKRNT0Bl02ovRq1Myuxw3THSK8m6YyKKtnRfvzPyLhlM5vRthQFI7MTcjSVxImsQ2W/KojJNXaZ
RugJNnxsvPMLKYqKkMBaBVBBF61+iMJtYoQaBIJKsXLezVPuNG22m4vUHcsevEDFPgqTw5y3aDRX
n8/DipbRWjW5UVAIUie+hLGAnhGk7iAfH7Q4YNn9QJMUTrnFhc++VvFIeh5OtCW2cFz4EESMKuoE
uFS9H7PWb63vSSdzk6IDdwvCmSZrLHspB4CE5W/IWcSpN2SgWAC7QnlJAlMSEWmrP+TPWrT64HHX
1FZlAQ4uzpaxmmzwjZhp5GTBz9FyUL/s6QGoiB57nHkt1MXQNGzPnRNob38xoSDXXtHBE8AnQDPF
qBKrRDM5I7/gZ914ee5kF3ThfG4wuEWrc6o36cqZkUYErTL7MUQrXYKo/ZX0vwwZnZTQRCzQS6Km
wTBR4nrqWCw9LUM6YqcXOpI4ESiG3iZaSu4goqgPien/gPAneDqCfldZaQTrsn2KCrorUHH+Nyvz
CcEd1ma1KEWvYBxtFfsRslP13Lnm8Os8inD/2irRoCgHUkTe+Gy9s+M4wdoM2lOXusRMYAJ4iwWJ
NBsyiakLDWEDxjlh5GUWUqYAs4eHwLzTLHTB0zc0rXqUHaPuLxr24IVtVJlDMgQCOaeGEPRFxQJt
FQ4g1T5kjZNM1C9SyQZav5nfvVuUdXdv/C5oUmlJW2yg0r4JUJpgsn1K7pJMAiNy71sY7vG4H6dl
NlZ2i3ApDlln7NsBZZa6tatS4vTgcC6mW1WTMaSJ9tIWldu5dhqE9tivqOTV7v+Q7oLYj+cNUDZ/
vPeDyktLNED03YT0mY13nsoir1MBjift23ks4XDW9lrDWvkLVO5kLliWd4MBPokRlqBq1sVo0NcG
vLrnYYRDwlPHh/sBzyEHU3VlMms9YCiubijksu/6yvijh+Ue1bf781iC/QseU7LaOGJB6ESfml+T
xEaNkmL0r1mHWwLFpXG40WMZed26zpyRn6BwG7eYjRJcCC1aX5pDtXROIzsiBOYNAMifqSAMJ1DY
OR3GbM7xnAYAoGnr5ehjXDQDNKaPSwNdxkB5j9rcaa1A8sgj8EfguCU2CsNA6KTyxFh2EJl62HRo
L2Pw4GrgTKZxz6rISYqr7qqisjIngWGc4K3fs/EVc4iyENRHoERt2IF1IGnLQ5YflzaVjOsjD/tl
vTYD487AIjLNrI0ApKH7wjhS4nbmPm391H5i447UBXp7DlOyp0vvdL2FgFRWES7Yatuh8nQnCNLo
WBF8wTxfZyimItYhLQ7nbV9USXUCwnn4fO0tXtb1S5XZDyaUuSS2E0/tVWvnuNcmqK2KnEgbH0qE
X5JN/l/A0eMLSjVCUfx+upgovFjmkfToLsBlmqLdUrF2WfxcGA+tUjoBO0JLyoH85PkxCzcKCjb/
g8r5FqXKyKiyAX01/U4LvYK4CFR3ar0PS6fK8Zws49QXL+QnIGez6LArcmXBMJv2Gn0t9uTWkySY
Ek4laq5AjGlC1/ZL7dVssKAKqxHmqsbdzWRHk6fWM8TtNR1qajY6WsG736MZCi9j1FhM8H6VMm4E
0Ti1VYKeghTTRDh0upy52c1KOi5oK0CoHYQErYs3Ufnz/OqJvPUWhLMZJUN52DLMayVs6E7pS0b2
KgS7mDs2knNB1GCnbaE4Q+lUkLYFGcZjTj7q+6fqPqbPUfUwdXsb/eFj5WfpdZS96ep+6Q9j5qKA
NI49IiNyE/m87Xdw9tPFlmpBDxE+D2whlf5UqLOHnAOq6ifJ1hCuIFQ1Vi1o1MvyV5kUz0YoqicY
sU5B9L6bieJW5e78CorKcVGV8onChUSRXUWZkQElobmntd40v1nqxaBeRvU+oJcDgxQTuYrTa425
U/9K0z/B8tbKyjnXWeMd/PYrOGudK1Udux79wnrsM9QSjqXb19TpIgY6ZeQtO0l2QTi30PcF6wDU
XtBec7o7TIsFmcKAtyx25WUtxfsOIz9pR2XZQ10Ua0Brlq5as6vKLQeVJXWUVhEmmEJIsvYnjzp4
MXNTSEKnDh55oC4+Qsu+T5zsT3OYd/FV8vwb2uq35Cb2tD0Os+cMqvfqQUbuKp6Dfz6ML4hGXqfu
pxEfVlsPaRA5+nJMdcmdReQg0AsKBWWVrbcxbl0XfZyzrNDRG9481Sp8RAKyjAu6+BqR9YaI5nkL
xfmieIaU5aJjOF3rq3i3SMEWcH6vyBA4F5TXXTamCxBKaKK0Wu2kstck4cmxHQTnXZJpymNjAESc
HEGIERn+mP+M1EMC0WnlImivNBmbk8gKoE/wIfpsWsjanO4EyM3nc6KtVmDsVMuv0Wwgg/h4weR3
NwERwSpQgJCYb5AMjAg3hwRWACHXi3bX7m3ba9/j/fPs9TsoAXuBG4CCw8mZg9poX1YKL3LZW3jO
MpQyp9m8DjEG1agKP43ImBkX8SI594U4iPUh+6BZOuz9dCotc0QxV4xhztNtbHpG8maWt5Q8nLdC
4YJtUDiHrRJlXLlc4bDBimcqBzNERbmsnU5Udo2QDNQRDOpDFKJ5p2MZSdazoUTO0LbyG0XdN+iz
tJ6C8KlfHJ2Wl6l9lwPfsHZoFLFlO00ETyAtYyGPhysUmGlP4bPZDCOtnFHHuKr1jN7E7ln0TKd3
UjwqtRMtHqp7LGwK/ZbIeLkE23xNH1moakcuX6PcjmgZ7p9Q50Q1qKr8sqraC1sqI8gSYayk6VDG
w10XF7bT8fXp0HazbSLfVg2Vo810BwGd+/OGIjhTCVkzeggdkAm1uXGoo2amzQDhZhpZoCv1F3BX
NNafPvZbiFTH1u48nMD6T+A412VGoC+IV51oZQT9lmJd68qEVh7E9HQ6nIf6OJo4hwIBSwSXpg6t
ZKQ+TqcvArV7E9goxB8vSjRgjC4IWxwK2S+vvyj3Q4JOm9J/Q72fQ78NLlj+IC8Yeu+5l17pruow
NF2c/yLRXG8+iD9LFTszxsXABy09qr5/zyzy4LIjsLwM4XXVzH9xIcYEGCgHQHspdMG47TmEFB10
BfC0VQIcqr2Gh1G/ty/RwU6d1zF3Suaks3t+lB8alV/n/ROW8z2kGZCeBN2L+5T74LYIQUS7h7yS
ExyNu/hqOdi74TJzJsf27R94usydn/bxZ3sAtZ3uhLv27QZkad1udgP//IeJoljMBwP1BK6uOnTD
Tw0i7GIQZwf4sOC7squuQq97B5Wl5QVXoa+Be2ntKnPz41+wLZ3AklPYIMwUbVkZgcMWQpb64FjP
5wcmqmY9QeAWWldHOtQMCNP74OkHtDPelDfJS/s9doMHihywEz4YLxXCSZQjeBeRnzp//sdP4BY9
r1IaZiGUoiHY6oCh6027Mrzy+11+/f5aXdP9+By4WGnFsxzqzZcy+mpRtdLJFHAxpE3CEO88mALl
cD3d5n8sF30o5sE6vr+UezR9BYWj/DAerAd7z+5n59f54Ysunifwq9/bJLmmBnVERozh09tbyzX3
w5vmTSitDe8huFhBmVl3wdYoI7IRnPKQ+0JvFapCcBrxHs6GYlWVLym4pgO/rXaUxMiOZ+5kenik
UbtrJbxASYWauBaKJH/EkT/JHgKEZ7DODLyjEehO4CH2dOBzxSqTQQjGXTpcrvXOSVXDgVNGn85e
14+lfWu1TgiS9ry4WaybSnb/FR0oqKg1MH6qo5WN29PKBGUrowf+SC+txAuTY2GHyAc/nV9gGQy3
h0cTTdmtivUN0Gi71OUVOsLflSb6pnUyXQmR0inRLcMywZDDUIXPDSkCj7ZGV1sCf7nbedE+uLf8
7Dg9Wo/aXj8Ml9M35br480B/IerY4SjZtdCBntz2WbarxB5z8yncsJukBRuEgtlNoQfsDbgD42qa
7HK3RhulO6Gb0xn26m65YMfz8y2646wxj4ZCMpAEIXlxalfTjA4izUgwCR0ky9i0V4jtdhBUHacc
fR3xfIsE60/0r/qklXHbiOIupMYN2BVu4l+eMsCEpNf1jG1FQnT6/B6Cb+cHJ9q2JsQRwTxlqrhM
8THXTG1wbGBWSTTPkxNWJQt3kxZmUC/Lw9o/j7b+Gn8cb9G4kCsJ63auJ6BlXXcs0Grbtbo/W4Ob
xuCkiF7PownnDkNDVaAKBhH+tallkPHqx7KDy4lRwtZeTWomuUGJEv3QiAZlLCqgPjKop7YRJuUM
tdCqc8tydqBA5SyQPbUby0+D8nIoiotghESFER9YYzhL27ulBr3bRncJpRfnh0tEjgE1kKDehwsC
4SB39JIhD/WhbzpwiVh+NXWuYQeX+Zztp2A6aBnZFUW2Y+ODVppurur7rJ+PIAp3aguqADS5gmSf
G0EPsgdDUx/8SIqfKR61aF+BFTe7nmNrBKlDhgdWJgnThDsM7BWIj3Vq4AThdlhqkEgJVXy5Vr+w
8UqzHdK9VpDCjO5o5UzFpalKBbZXf8Hb4hZznc3NMWkGtFHVFphhmzoxXqcLXXHD0c91ZaeWt5N9
rWWZY/eoqNn1f5E+JFtwbttFWUCmZAZ4Pyrfuza5MK3HVuv8BG2RU1A7xvx23jiEUcEWkd96hUXb
qVuHC1UvC7mgqHhNkbg0Dc8MTWesPR0aJqD31MGf1XZOpu4h4VJkv8f5ktm/JV+zmuK5yefuQ3g/
yUJ1wtdACdSzp6uPylLqkclfgtRnwV1dvKhKDrKm5zr7rVgPEnxBiRhhSPKZcOgGHm25rUJTrakj
0mP+yWODaMiInnBLJ+RIoZTNdnaK+hjZG67oyrXF5MJSI9a0ajKGzm2zh2jYWfHFrEDSRd9BN9Ip
Q4lnErha22K4SuOBTsPrGrelKFOjgqkoR8vbzOkU+6FuLGh7Qhc1/jFUsgfPdb249TxB4zZTE2iN
GcZryV0Rwmiuc5CtB8wrzW/p2Dppe23oklNZjIgcN4TM1ipUbnwo1TKKtEVsyeIMal5IyRnPCVru
+1x/GPs/aB0EUZusfkHk7m1c2XCNR10Lyvw4u0mMZOhMipogyFK29IaAeJ2QwjEaXx2PJPOVJXMN
BXWbP2lfQgLiWOuH86YrONROvoCzomgedSW0MdM6K1+KtqqOdkcayVEiNJ7NMLnJNeJRCcu1hCse
wmMYxq5J7xszdvGStOuMvyjqxZDw7Ic2YxxcBu8Mko7l04KltGPVZ2RxrfhZi+PHrrR2cwKr1SqJ
8azf/8VcPxEpR7SHsE1Lhn6tHkNtYUWyQ9CGbirVAxGvFep30N+Mq9GHT94cMYppWGOZoLBQwZXM
qZTlhyrTShM4FczdJwTn1gOiVyNZ6+DUpDggMQqu4d1adlCE3gRuNqK8nDc/oWXYBAo/Nmim4DpP
T019ilFAtirNKYUzKPquDW6beG9lrl7M3nko8WbbYHGmPhQ2RKBGYLGlVO/mrrq2Y/O+X+x9NaBS
UyfKAzFi8Gkho+xMbTbfQSJd92saXfRZntx2Vp5/l3zTOr4vlrP5Jm5n2EM1DnaMbwry5AkqoD9y
tbrJsvQ9GJ9yPACmoGIelWBP08RZDFC7BeE7MSFHff47BKGebW0+g/O3ZUn7xFpLViHwNtj0QoOw
XDA9MZl2uhiHojQHyjzM4tuSlrYo8U4FnDh0LXXPwvRYou9KWh0uCk8woE8gbq0NOkyx3mNeB+td
jfq9OXdIiQbsexgVBz17NW1INYJNRZ87L2+fWzLc9dR+huaUoxXpTTKjxdSWkUcIN9fmo7jFLvGA
P6kRPkqlDmFXBuLE1trnDH0H6FSZZsmiCr3SBo5bVEVReqUhmOx+Ru6786bBK1FP8zeWg9VctcEg
AcpFnqMK+c8pQblfXblQQdqBM9yhKL5KNckZIp68TyDOM5WJGQxzAu28tPhl0OWOxfcggKWF18/v
ejBKPLrYUD/RuDOkGaM2RqkpNoSu4+bqqHa7V7TmxlYlXmn9oa8O4B8g/ugoc1Dw0RwltFH82iJr
nqle3uXgvH6uI49Z6SVI6c6vmKg5H0cj4lULoQcEx7glSwNULn4UIi/5dJgg9KWhnKEAJ3NmlDcp
iCIVs9pZ9Fff/6HFb4L2WdwEIe5qe2afSz5GZKPbb+FWdaGkTosc5007JoXToH7AG2s98ow4Sg/n
xy1a0i0Ut6QVLTMrMQCVjuExGzTQvfVHiLqDIExG3i8ZFd/ROvfVRCa0FrlUU67LGhl/nRxMJnnf
Eh5omxHxbaywmqxkAWACJdv3sfGslKj4pp2vhKD+6oibaqhkG839KlY0D4nPYrwbGoYTjzINO9Hu
hFeHVh8YNpAq5RJ7ljr2Sk1hxm04uhmEHc2Oua1Nr8buLdamhxGykxLPs5opv3NArIjKCguZtC/C
KiOilCZapVb1Wf9uN5AQaMskA2hRe7VOZi8MZUJe4nX9hCSn0UpQBeitWuV3mVUzN1QWy2/iEVqo
A5U9cK0T9mV0mon3LYaNqvInZa6NSsx0TCi4oa7j8JcNzl+i9nsVGlNJ+ofRBFEgJBFJfyzVQeL9
1tPxCzjSvqaJouc1+Xw6TktLdH2sAV7NyS5O6Ld0WCQJfuFUbiC4jU+SKVHLBQ62N9MdyvoPapZ5
ZSTrlhelgsAn+jkUbtfrBVYpWx15kl3p0fcxilAUfN8SL60vzAisCuqLgq64v3A1OnL2BBps6zXk
dP6K2s7ttsWhaPa46+TBrkj6PYPOnGJFkgIjoVfbQHEm2VMTbbIGoCLL9CfEEMk84tXZvoVk9935
UQn3ON5kdJzzKFHnWzRT6Mbi3RVTqWQuolX0rBfgPkBM1eRv1Ar/ag4/0bjopQnT1sjWwCLQrk0L
T5jJ0Y5iJ5WlOYVuZDMqztYhiaiybMao5jDfTxH4U6o/ttpeTNHzAEnc81MoXq3PQXFWX0ZlTbK1
O0vpwNBqX6fsrQvG21Zm9qKowt4MirN6UsRdSiBT4w5zbHt1GKR4jO7uOza+hGS86ecxdkP0n1xm
ZmLIVk4IjtoOPJ3ZxtoNemr9A0qRVC0HOAWVg1J50/SutEc7j52yfciqP1KmWOGsfgLyyvdVqKPh
rgZgqe3H+mffeXb6nKuyXkURHbVtb3C4bY1X2DpQW5CydR62QOjHh8DrUYrrGA7d/1SuZ6+9Xfzc
Cx+UK9M/bzlCf7nB5vb5YA/JzMoVG4rvNEt2jNjHXJcdquLgcIPDXcgXCkHKogdO+tPwzQviG5ZP
v1X+vCu+1aAWxWG3B7mpJAoWvcadTC13XwtHXOasaoV9Kv0s8pRD4BvX45PxO98XhzmDXpTb/IEU
F5U4NeG8fihlGigD/lJohWazuAwCAFvk2tbQkFl7M2tkw1tX58uBukHhVk8hXaxrq+UkzZ62txTK
PTmKxJfWg25BFZZ+OO9r3M1wINnD43nLEe6ODTa3okXOhrhSgB12xuWcAUStr0CAsm9i83AeSuhL
N1DcKoJSAvzkIaAKZdwr4IwhcwLxNBQsmBkqDun383CytVv/vsmHTVVQ9VkBOM1+rbT7cq2bljkz
2eytf99g0AxJIyRJMXtNjKPhPu8OIbuw/qK9BgVqePhTddRz4cnrFKbt9C6yUhWnUHGZKV5TvUdS
UjbBIwUaTSjew1DQiH8cRt0NVW4RRHW0e9as/mIcq8Ybl9dFaa/RiO4PS/VSaI9pUT6cXydh4LAB
5k69uC3wm2vgECPBZ9duucCRdIEzoi7KTCA0bNK/eK3YDpU7gnJqxbNpraGKisbXibAdOBmnYLjX
6rVWTJXw3a12/WV7fw6QP4CiQo2iYY1Vkg4tCn34c5jRiHV+EmUY3OFTQMnABp0xCE+xargZBI46
q7KUkdDaNwPh/NScddToW4D0fQUyK5W6AbH8hWkIv0pZMCQqsIFBrl3XqOJDsSu3f+u21mYyY9rq
5FAu+7i8S4JX1Hgb4WOnIwE5PxN67JO7Kjq2ssd8EeHICTi3scexK4t4bYU1Mj+llwa5Ds1nClqF
ycnwoFZfadSxBslpIwyNwEetGUQliCy5ES91xdoyBmih5M9ThO6GJPZGQvyKGk7bmhBJTFw1V3bn
bUc82A0uN9ipjazJXOPOBSU+c4xnWjN0Amv2p/IJ3ByuNj8VEAkrrSeayjJcUnDO7/RtpjNwAiF0
SQfULlyXxQ2j79CT8mJ20bN9HXhhcwhk6RGhLW/GzHkdJVxCG9TU8AHEbxPrvu5Nhwb1TmNP52dX
eAxtgDhno1J1bLoIQBGLjjMuk5ZS7FZyl/MwkvF83HQ3J1HS0WSq6Aoz2YFTj9NzpC+Ogtd9re8l
9xTZmn38fQMWpQbe9WuAJeSPVvmT7gbhMcBzfr0SN407td9NLdiPZcoj4kAQHd0UfcMmiFo5N1fm
OcigQsTyXTM6IRiT0ilEJ4Gyt/Tc0ZvyQLIZ/98cDTXxDUy0srCHDA1wmf0067+rvD+en/b/MhWf
X8T5xKpBu+TcoPt7qO7BPjEOt0OGfr/ogoJqn+l7BW8lZufboSSYEhV5Q8rjE5gL3FpoyNDCwlQs
9WsT6vvOJM40mbfmbKADh/mVEjpact/l88VgTXixU480yo+6+qBn0YVNg8fafBut16IlrtoTmEl0
MTA8JI0k2nel9rvNGj8MU6cuNdUZWrx9rIwhYy0T7hKGhZuBcGEhMe2UzhQDyYa7oTuGyXuNMiFD
9cJplqyW2MF+zhnnYJugGuxgvXvWBFqcD20w7dXqXutuDdwpFIZnl8fz5iHe/J+AnGcNGzUzjRHW
URkB6IfsQ6tqaNGc/PMwUivknWiBDtlhWPdFfgv1jtoCmU3uhCqKv45p6uZ974EUetSkrwWrlZ3G
NhT6xBSkXGhjQ26Xm9HKRjUfUREAV/FVG8T7wLgwYfG4vvTJW4q01pS4Q3E15V7TDw6eLSUD/zrB
wNfWVkWUS6qMf2BSzEFv8SiNALwGbU6L/NYuVS+NmHhBbXk5nV1W3jUqJBcLd2m/UTB9Z9GtOv97
RsXT7+COE4I2/z6q8R1Rt1Q7JFdG8I+AjdYomtugTGIHjFTz7vzghWOH2DZydSpF0MB5gHEhaZhS
HeGYfZMZh7B+TGWU1etnf1lelMFa1MANW+Vl0YalxTPojEacwKzwRgB5BwoJE8tAU05EPDu4atHX
IjnJRMNC+am+qogjfc/XEimEwaAMDGuab0xQwubzLpx+n5+6r+EyTpANBrcvJ9MOUTdv4EIVgcoQ
ZiOtv5KNgtuR8VxnwbQuTh65A3L0802dvZwfxPqR/OJsB8HZXI/MgK0ogGDFrcJ6kEn5ZnjVtf86
h3w6V1wAM2I9tHWbuVN9rU+/SjQ05PeWLnnSEK8IigyQZQE1gMmh5LM5hnOGFenJ6HThLu0kSy6e
rX8AeIqKIJ6tWU0BUM0PTbO+q0fBAxkCifV+PWIwW5BrB0GaBXYvvmYrZJAVstfZCoYQhJUod4fj
XaqA/jKTvngOqZL+glhi97gECcTc2ywNJLcI4UA/up80VUfXFTeTRWKMamlgoCSM0CZ+zFWnZamT
y4hKhRZOAQBxLKQMGBeLTazO5xb0mmig+2ENaO4JQOhj3p+38a/BAaZzA8KFV2bElLpbQYxsb8V3
y/iQDU84dJy+byUrJ7TADRTnTssw0LLFAJQVXJlo2yz63D0/GKFtbBDWL9iEzajCNStlAMJovOTx
YYIK4XyjVd9b82AkL+UoeUQTOW8NHcXw39hRXxgSuqltINRnI7AqHwsdjCVo+W6iX1H1brAfcXE8
Pzjh9G3Q+MGh4XBE+I9XrflQZ29KJUnaCCcP3Xwriypg+PxUqqfhGA4KzG147sIrXb1JK4TW9isz
XhKwpI/v58cjNO9VphkZN9Dl8ZfxYlDn3FrCzk0GA0KKmtNWCcq1ZYGDDIY7iRqW2/lYASajR8NG
J6AOpyA7UolwcTaD4U6jJTGJNa+DaXblDZgrjuEPGjotRdOfnz1Rt3DNm8vll/7AvPHFQjtg4jZX
YIw9P6WCkgTsZtuwVhZQhIx8H6Je6wuq52L0CmQeuZi8+If5ihb3Q+DkVykEHH37UakkoOKhf2Jy
HsRSBiOqbTTeIkI1h0fy76s5TsfEuY2mUxItCfD7kX7VVAfT/m7L6OTFNvI5BG5r5bE9KoYFCNO6
UegxtFJHyqMoPDVsC4e5qa85YO7UGKx4gXgMMPJ6JcX5iYzTytvS/vs+aIqGObgl0H+Z6zl56gPV
tJ9w8K2de4MJl76kw0MWWBF6QKyevE1pVP77hvVTRM4AlloPlTBHQ1UxPg/VhWp/P2/Vopnbjogz
gCXVqnwg+H2tPVTDn1GHjvu8H3JZild0FBJcc4AFXpYv1ZGzpiXoqoIDVCdPGyOHksOgHq2xReB3
OD8kkcFtoTiDU6ICgk813EWlI42zpJ4ePddW7P1vKOtXbI5DZTC7MOmAAkadXBtcPMua4NL6GxBw
q5griQ/qZU5Blp7YZmevQ4HQC6Q0DJCjRbJGZ6EJoFXvPyBcJN6EKMYJI4DE6Fha9Ngz0ZCaphrk
xh/PD0eIxNBuhT4v1QTf6elwSIWsXqJh+zBj1cW8TaZDoPqDTLhKUBiD0BXx60r0C+HTj+T8Zm2m
dI5JjLysOzDDrSl7SiBJa+hL46DD3YFimzvn6G0Owp3Zyqq+V+vi7zVbbM76rLnTyxFP6S4pFren
zd1ia5LbhiiYAPODhSMRuUTGExyF0RIVsJe1rCPEedsXg2e04KlNehuVUyX4SbsmSD1iNWB4G3vJ
g5Boe+EIhMGA9MWAwz1dxIGRgC0xQiUGgRwrBOV2ZV0FVvcXFwEdN6m1Pw8cCDw1bp8ptoGQExFZ
4BN0l4VD6XVg5bLr3XmjFI7nE4inx63ncowqE0C62kLwV2uC7qHIq1HFZQ4qmJIdLbbNDRx3hCAV
Wc55iTDajCcHSqNOlqgHa0KEmzGIucSF29mojp1u+2qRXRJEMTUSLmgfQcIF5Nvc0umFFmhTbOF6
h3yTYX+rqgjcjvVVlBLP0H51oOk5P7cir4/aA3QAqbjOqXzvGLP7yeiK1evTsXHULgohLhgXB1KD
dnbAK1H98r8B8rvPMlO9awBoZyWSwn9CU3WSEkEiGxxqTM/n0UR7HR2YUGKF7hroZLiwA8V59aj3
uKwaE/hSLRPvBjL9cOEMggcENWkMsSe/19miJnq+WqdGJq8w/ZmmToO2fFDsdw/nR/MRJfGuCz3A
eLpDnA5eQc40VdwRsqztEAwe7UP3Qq51sN8508t4k7rgECPv1nHcLTem8724Nm/nu/n2FbW3B/vA
QAGCtl7//PeIZnf7OVzoU4+LukQVPmddxCko8Sj8dB5BQD9BUX76OWJuQ8RlrhOoKXeuvqM3wTUo
J+46jx3YTX7RvyrecFFdmw6UcjDK/KrwO1moIjoQt/icuXakrVFQBnwDnJxZdmXFN0GpeCWeKs6P
VEDcvo7UguYLnqPX9T312kmGUs52REcltumLghMwnQvPnMCUZQb7LMcdvu8g44euMjSRoibEU8te
Vjoq9H0MRflgzQUzHx5cTj8iC7SlNlrcoJK0vwhofMxNy0maftcTMCFkoTPMd0kEqsLo1/nhi3z8
FpgLcfAYX+M+B+ApLJw+PhToYO2m43kQ0WIyOFfNRPoXzwrcFKuV3aSmiVBaYfslAHvJ3jLf6CLx
cILKgvXMB9UEMnSQgOapO9J+NIwejDiuFt6ZEKJFV70bp9lh0NrjkHaHmM4PZvWKtl13CQu0iWsX
pIgkHSvCsdqISlEtCw4vPuGpKIQoKD4Gf0eXuajOTcrQyRsf0oPn51R0YrFPHD7vORVqa6HCBhZT
JN/0OPFrrfqxBKo3kNCp6l9zLCvXEwVXFjaBaqCNBAXOnE83lhz9ExNYCoJYh2KKvuSHpkRyMJmC
O10vr6dxiFxSKoFLNCITaBJ5exTEr6IYa+KQP6Ahh9EmzQwaBp2+JePdkP9eRndqd9O/7yNdWwt0
SGgxVAHrfJoVbQtKmBI4HtN6rtpjkry28Xtavf4fd9+1HDmSZPsrY/2OWQABuba9DwGVSJ1M6hcY
ySKhtcbX3wNO7UwSiZvY6ft2ravLqopkengIDw8X59TsxxJsxkx6D7IEYN2IKA7GE2ViZIM2qXtc
/5hRhJTrxuyR02pNzjtwoqlwpsKDOYl/4pfilbPxmku5E+PahWBiYoHFprGC+avTTsyqLEzl9Y55
VArDL43iccHKzK6eCHyLsd8T/03MmzREyMaMnfJKhMZccSuwlHBvbPDgLaEuzh0/5ULSxJ5FYpsq
/igJ7x8KIruMfWtDTVjCHJ+1NZdyJofB7WTSKaOcpEKlLLdqaESTNTlVCL/p+TF3NPH+9oFf0Oz7
Crl4ujlt8HsO/bEXHx2z6VMagmgqvrstZ6aLErsSoQiw+QBjjp9G84ZSToHM3OHqtSSNW3H3ZqqB
Kkw5cK/uedACKz8CzKOlw8ttwXNX0aXciVdTjaTzqdJiV5bvbmMDQs5Vzdsi+PEzpo7cpYzJiWvY
iKQhAxmNGfGUfwSHuN7Zil3qzjm951o90Qig8kTdfYu0DfoPtL8S7rkcweTsRYHMECbC7A48fwwH
1gTglSahoGNQjk1e2AsKL03q5OrtRbnqpQ4Ky2fJSg3ugwFdNWhH3T3aKvpW5/RI9y3Em2o69FR4
dq1hjebZD+9RMZcCQ/+X2R8ddkBsolN/MvuVL7vS4MGIs5ZoppZj2bEmcVQ2uX2ulQB1MwS93JJP
zkavc2IFlvQg/YU3OoCo/jmEyfR3gwPiSRHXZh2sUf3KS7ayBNo9e1DBowSzzgqgYZwYu7gUuJxN
Ry2zX3XxpQoN6HLOUvN1e2lnbeqFmImlC7s8Q003xKC4u2zeAR3hpLuU78B+vuiezssCKqiK/m2g
Ak12UTiE3eA5kOWCbiCqkemUUGjzVrmiJrUoGpBaDYEKvCvDz0rydblvdqpY6kMh7JhAMZno2Lnh
gj2c9Zmxk/45qHEdLgyiUMaO07A5LhWQOtfgRWBiTe3tHmTb0vOQrxR2T5bidOP2uLIfgIIiqOXE
ZEyLV9lC7VPC4+aMFfYUxtIZ5/kvOHZo0f2niIlaxAuZrs/hFPAJMYpAazmLDdFR49o9s/aSJXs0
ayAuxE12a1mrFeONCEYEEZe2QT93hEAgyNX+wm69EDPZra2UcV3tYOKkkFu5pZkGrI7oiMZ0erbU
yDirEoI4sDLwNNVvPM+LjeHCDw2aDBuDKwGFmktUqIy/QhAHlgNE5gEKJvDwiycTJyVFVMErRe6N
+/KIXiISRwTTdzQGuLlxoHkSUF1Wt2dxbvup3JjOQT8ed1UnKQ+dlCsiFiuLgcFYkH3UFgsGcs56
XYqY3MJMDnDd3IdajI+QqXeIApoA2olkD7dVmTMpl3Imd4GfA68LDHNwoFDEoJSHpDSGLqFealRL
TJ1LoiY2P+dTLiwFiAr5RAcqcFbwaOPVimob+R+3tZrNyF6qNbGURRJKQATG84FZ1T2teKrsKlsw
VI0/ZBvQI+oRDTXOGKy1cvDuHgLtwdWXHmrjWZoaqcsxTCxIXNRtzVbjzqwTI06MdkjNtlapyG0Y
FwWRv27rPHfcLsVNDkIO0I0+VSAOaOv3zIi8A+RQIEO0S6ZqdmsCGBRxIQ6HYBok4dp8IEwNn1vI
zYFsM2GnuG/D0m6Znb0LKRNLpap+FPM14kF+bLVKs2IYEOQ6m66MjUw5uouY4+NL4Wq1LuRNXhJJ
jvYAp4FWwP5TvmREC56Jzp7IE5hI3YZmrsY89jq74ve5WZnOzj3/heVD2Esey4qAMTTZsQ0Bq7nX
Q18GWYsQME2+oElLdH6zhutCyGRLur3kMd+T6qS+zvJPPnCKb6sxG8cDwY0ko/t0LF2bGJQhBD9J
54wvMuaQp8fERfk06lQ/fOFX0RwkoONlO5exQvb+tuDZ7X8hd2JdHJ4bQm888eXggkoECVwZHtHS
q2x2l1xImawSUzRxMyAgq+XJXkg/hX7L1zEFH5KbJYBGi4xUer2t1+xpu5A4WbIuzXI1ycZ9Ua7V
4MVvdm75Ii7d1TNSgBqKugSUugLxfpoHadiMHSoeUjKH0QKZmFGb0lA5NJy/8BSaaXKFiAtRk4Vy
Q5AuyQmeQh3Qw89cQ4eVvxssZicci4LGtqv1G/WFW8jWzZiTkXAFfX7I7Y/YZD+91KxkauK2CEoC
eUpBGgkM2UPtUYEbGXkNMPTeXrWZ3fhD3ETJirSR3IYQl/HbmLnjghXH3N0WwS2pNNmLqHZrlXyM
sxbiXYtOm0KPm10d6UAqRWzQ4JqvSjALZcMqp6LZiMmx9A+lq9cwbN7C7M49KaEv2smQDkVz4zS0
zJWsyAwtEueZ7u7JAfRS5/RN0O78bbOtVt5dbcYgyF6F2wTZmbX3UC4xa804Fz8GMDkmiQMyLzHE
ADrHdDoz83RPfWnUfeYtZSoWdZ1ctEXO+pEvQhRxdTTPAU/KpcIvz/wMtx+BGTylnO7b7rGlybam
/n1mvS0FR5eUndyNipKiPFTFytex3gq64Ja0iA3ffSXB4+1NtiRpcitGctpXiQRdhV5rnE0erfvo
ruzPjr90cYwnYnL/Xi7gtI0ThQRECApIKniQ3L9W4YJDPRfl5cDmLOCpICrw3SeqlELGO8LIkgCC
FNE5oJuhi8ycmEOy6TsdyqHGRBsEceFCFGaOKTDUcSiA5MuhnHeStPTcsswiZJmBOE30AvYN9NxI
vQQVgHFbI1IcGoSaq0qrONu4zY7xNkCF6sWNRPat+Cy1Jz/xKd8Dodq1QkcP0sZA3r1lN+Fgtqku
D3j5ENoLdqA4m9oBcrHSGQ2KD5HX1srusQGuS1W98fWYRdNksAdl4aYvDnLFmp2HPDRKF8AkvGQB
Z3YOD+x0Dsh2cAX46Y2CgEyaMoMIPwAW0AX7DgA3Qk1F+k5c6vCfm+FLURNjm7bgco34UZS/BfVN
6WmkDagPTgBXl7IFyz4rDN2jEoceUh4tYj8vEndogUdIICxqVArwSZMF8GvFPTPtNq33QVaZt0/g
zM08CvqnvIlhq8s+8fEGxauJeWRlIPvy924pmUNt3JazpNfEqoFLk2SlNOolol4UoIAK/5GKFhk8
K5MVW1mEkJoRSDi03QNiCc+WK/RJhvcUB3DctcYBcNXNbH947UEtkOQHnzOWWMhnZhHVaYqCpJUI
pM7p9R8ncj6orgpQe9HR+uyhdwZEBsw2WdgdM/f+DzmTrZhxxBNKVq61RD104S7i7v0lyoAZQ/lD
xGQDkoGoPskxb5UjaDxpNekvtB4Q+ICAn0LkFMniyVbgByK5iYfJErz6qUoGvcm8uyRY8Blm9biQ
Mu6Pi/BQwymM5LOQEsK+kQqkMUvtVbOLcSFhYvEDxlP5bICEPP7McoMAV5JDmPT2uVkQMiXfEcSU
uDggtdah8KUS7VYRYHkXqvMX5mrKSKXEeSMLKTRha/HgNbwODgD9th5z+abLVSf8z/UoCrQcI6NX
AwVj2PnSVuxDrQWgZNUTPfOT7VhqlngtHuMsRc8IEt2Jhi563WsAOtmyltOeq3ApTzAu0cQr+DGo
idueNEFSqQxmN64flPSc93vX3UTlBlkpLjSa+nR7EmbNxL92zDed4sWeDBy2SQJ+3JN+azU+yI38
J9CKOuFC09fSek7OcN2oSpmp4xkOg2Nd5Js4ub+tyZKEybWR5q6qdCwkoBnGSSy+4hb2/Vzc/8fS
TKyE5EcDuMowV5HI3itBEFBlaBVaq/2xaxhDDRWz81NalXcq2pxva7cofGI8PHfgRKV1cCDY+9gp
UAms5fUhHo5gZusCVWuZTcLwC1JnNyOiXrj6kXO4yjqUhSK5AuM1WgyL5SSGL6CdG0XPHZoD36Q7
9i/01BHwdgL4HQWm/BU7otIJZQb+3gYdqM1XXKT3HWJhNZfoLIoxFyaUnzlol7ImE9pWCh/nod9o
3LZEN7FLw232Ju+c8wN/V3ykC71TM0gDKPG6UG1imhUH8HJcAnHNB7v3H+VzuO8/c5VmG7nXiKGL
9qN4cpdMHHtbSXH8+sXxzmQ+Aj8KpOJ1arRfTUzFnWB7EfUAsbIgbM6UXGh4BcrJZSmbdJCFRKee
BLk2oKQtuFME6/bKzd0/l3LGhb3QyRODKKwCyImJakuRsPEAL9f2SwGiJTETQ1xzXkHiahQjsprS
rgNE15ai9nPVHJe7QhyN2oUuaCGV+3oUwqyQjLCK5+A+2XJ6skmfhXMgUX/BDM/eeZeTN7HD6KRi
m3BcpDJ5dN9A9/ta6SVlDB8VlZVImc9sw983qMo/RY//b8s2sc+wm1HhF5BMyEerPPKkpDn7cFvG
onoTE930Icew496QdgTVTa8crTb+eoRtbqFS+jysu2Oog5WFt5Sl5/aCQREnBgW3tuR1OWQjL57H
lDsISMRTaWTHMF5YlBXICz7STDnVWJcGCj40FIIAddrZ7vTo5MoqDsXOmY+3/SGO1mEA7jCdj0vd
D859vkucVV1bea8z+T4IF07iTIRhHABgF9F1gMT0tK5i6AB6EyWotlZRSx42kR5n4M5GjRUolx0w
ptq9J4ETxYiXECc5eZzNn37ST9GTk5MqLsqtZPRFh9LGlZGTjAGTuwpbG9zZjHqI022RP6fEKuRH
VaQN+meY1CDsJ8e9SXijiJTtwhPKQ6nqsgYBPma7U3JnNTShJmf3iJKAfCBOC11FAWWZNbQqXoG/
oFXVwR1AmZGtCO8hQWk3QmmCgqUvt+UQIlHzqgyMwVQC0AZMjl8Fg5HFtpivUyYx8tZOGMsJbCkZ
aBXbgwKkeKtozmG3cwhw+hLqBq4eJ79cf+MCwVKCVxGnujoco+CQ8GgDMsH+nmWrLjkE4FfsTbaC
v5o8AvSOdVaBvFLUxzQ7Ad4NlAabqD8BvkbmQl0pVnJ+ViozDgnNmq0orQP3JKVbpnnw5CcVCf9h
GxabFKR3eWjL6V0cWkn55rT3yJsk6lluVqlE5d4CZ3WC88M2AFPzP0oBABWHdjDRg2L4gCSJn9ny
JZV9wFw7oFgwQmnngcKOe0iCM5O+kR6EOQ6wLEBBJrmYrh45NWFdMrrqf/CpqAnuC9vvQX/AZL5W
I5HCN8EqVkxsPy1IH5x8BXzbofqqci1Qt6xzQBirKR+U8L0Fgg9wtJp8nJANOK8TtdPCxnQFo2RL
m0FTRQXcQ5E/RKSlbKpYSviMaiEz9g3g5y7d99eu09iSOlK7CCzSQtN231h0nUL06rEYR+Ns2S7M
Sq8Nn0bbklYsZY9kByhbAzvszLpokF0whDPiJcSiBFXlQKsLJvSfF0seiWldjGWCwRatsVqrhVpy
KFjq0KezBMLOZP2BxNFTaeQLis9QaCLrcCF5cjCltJfkApfad3kQGoXWOR2eQF0aw3XV7mRD3mVG
ue1Xni3rmR5YoK0FNI++dBPM2Icfw5hcdF5TppXbYhi8BqQxiHZ0yYIxbs30+QHY71TV5W1In9Vf
t2f+2gv6qf7kmgM5EWAhZOTLACTlxa8Z0MCyjNZkSb9x/BP790O/yU3HhjGQk0Tkr2Ia7wWNbDwz
hJ653liV4WzKVa0thZRmElk/dZvccLFHeLVSMKfxIxi47MTMQXFsIP6ov1W7fWSJ2hLkwJKWE685
IsDZ+a7fldU1ES2n2xNmdXvB5m7Ri5lU2YmP7PUZWpSK8ahI7jsrrgY2sTNgv5btGzJOuhp1b1XL
Uzn0AGusoL0GLWmt35zGfszbQ5nhwLuc4Cskb1WN+EwdU/JwBk8qSGLMxA70cO/o76HV6cMdbjWK
NAstTYU2Wmui2l9fiwE93x7I1SZWCarDUYxL0E2A4vfJ4WkZr49Y3oEb1Rcmr+RaDuNayju+v7st
6Gp9IQiNoSitkABphwa4n2ZKjYYok0DYhMAb4MqlBDRDBuHN20KuV3giZXIm+YYMUVdCCkBVge09
wD+jaQCkX9Te2kRLwC+L5FW8YAmXdJuc0CRrY9nNgxb9n6cquM9Es13CtBw/4ocRmCg2OZCIWDIl
W0MxJmBZOwrz+IlniBQAaLFPd3IdRF9MHXQLccy53YHWJRnt9oDbVqYPvTBAmUwzRC3SgRZbogmM
f2yLDU+eF5ZtSc7ocF88jgaBB5RwjwlU4dfpXGdKlrvmXwAJ6G6Vc3KXbcRdaItauVQJef0sG+eV
B0casjjiCHnyU7IrD2qr+iG4JWycOltm6VNBG4NY6Mswxn4lbUHV8Tq+WsgLgZOFrN289osaAqVd
tfURGbZUTTzJr63ZWd5a2S+GI64CAxMNJ4aVEfuklT0IzEWz01OtoTwHunpNMBOQaizYtevE/U9p
38Gti5WskyhtAJaExhmdOyhW85FGtOwNXhvfZ4MlHUo4Rp5WvWE39aule2v2IOItAMhXFE5edYH1
XJom/BC3KKxCSWuzascoligtKTm7XQlYQIWxNVSYJhGkSpEzFdMKZ6v+AnWGJhnMNl9n785RNgqE
Q/bx0TWrJY7d+c0KRiSkLkZXb0r/UCtD7UoK5CKx9CGcUFhvOnr0zt8Pmqjlh/p9Ya+Ox+5qr17I
G79+sZgiw0eV56WtJvOoZKlAtkmJ5lvoT9RbltZ4/S3M7HX9wbh9LiROnFm5diIpZqCh8ur2NEec
2gQSZ0MDU9K5npaHXpctxkaDyOqr0+TXbM1sg4UO/9FtvdIaWNkcAGcw09MawCLKSiUlozGKtgL3
pdSft6d1XskLARMTgMqyFmCksOVVJ6HKO6W5EGgBq9wlNcpT60xFvQtS+QX63noBIWgPlGlIcrfe
ys0CDeADlJccqg75oc1aO1QI5drirIgNQn2Mv/TAuHbzxzW5GO7EgDShEuYsP95uki29tm/gO5NM
75yt7jJarpSP2BxaPViTdadxkt5pvX7+tytgfg5BnThuhBG6IhIxY/Fg5+wrU58UX1OVpwQdNrcX
Z3bxEWABqSTO9RUXc9CIuR+UsF8Dcl3JkO27jrVui7gOEI/aADkCMG9oxBWVySbvEhnP09EiA8tb
RDv5vt6b4gYwtP1LRd17cV0BQl/zzcK8LXjWbF3InbzXAqcICfg7sLF93hayYYssNdA+e8PzPm5L
mp/Ff2k4cfZAKSEOlQtJivrk+4+Cb9z+/PGETI8oqlxQ8oLiATitk7oTucw8QHrl2JKuaJUIejhH
tbtrE4tLon28VO4xp82ltIkZjKVs8MoI0nr1qXbNtFqqeVoSMNkQkuyLHTcKkJTzCAXRrG5P15zz
OCJnIbsjolBnCufB8T3Q/pqiBSTLeynqaWWVvoluFtXVbgua9b8vJCmTg5p2aKuVQ0jyCdtoiech
4hwGu9j9BaoY0+UJikujSk8a9an1E/TBJdUj26CbQVTSvROVCzv+umIXRw0gpwLYhVFneoWXAgaj
nDQJxhN+cZRT9QpFRSVNt3sUKSEgUrELL4G5I6YqKAACM5SKCpqJOyn4BGhbedlqrlOD72ObkRjd
NUZa6t8T/R8f3X+6n+nxH3u9/O//wt8/0gxpFBc43z//+t+H7DP52zF6+/gs/2v8wX9+4+T7rM90
/xZff9OPn8GH/xaOF/zbj78YSeVX/an+LPq7z7KOqu/PxzDH7/zffvFvn9+fct9nn3/+8ZHWSTV+
muunyR+/v2T/+vMPJDYvNtz4+b+/OCrw5x9AcH/7SK9+4POtrP78Q/67AHiVkewCWEoCqmAx9+3n
76/AG0Q5E4gJQR6EirU//pakgE7/8w+B/B3tXQp+CllIAmcOlqQEuMLvL4F2knxjA7Pgz+D++B/F
f6zPv9brb8B1PKZ+UpV//qF+18L9y2bhKlHwxIDvhjp8FUF0fnI0ZI8VezBNNjTnT2WuoVh1cxL1
XhtMTwv0ZrXrZb1mERc+I8K7bo1Ejy3fkg9Dbw4BgB97unl0G16LU80CZreB1E3/3BV0XZtAbQjM
9rlfievGqNatu0LUl631TqHl/rE0Shqv4pVsKOZQbPsipxkxgDrBx48ssDU0klUUHErI4tF414CU
x6cNBtZrndnoCmd0JuK4gP3Ta+1UYxQnBJwMVY8sz5YMz/L1kKYb70Rgv/ptvfE9WtPHmnpbds+f
IpuFOojLm/w620oWb2W6+LJh9Agfwujsk7Aq1pHBv/umY9SrR9j0M4FjOUpAlFk+hAA42Tom8Q1f
puxd88LvarTMnhytNLiDFFKRPq5Pj48q3W3Gv/TAH4zs0ngFmDmVabEttnhqrEMAf9INQmj02by/
d+k7usK2Y6A2vkvxj+FjjvC/jCeRTDesxQOQVNb9QVNVWj+OLJa6jM+W6atP7zFXNLArHWgltNPl
D5RSUFQfKvS9eCF6eFfpACTcorVi3wMTyn/g+OTOl+A4B3Cha7fV5QQBn1P+MaArNltVGwGRH4Gm
BBQCdGzJ2Ion/wi4JQuxPcodqqGhbml4scEffOhervFLUg6tfCyeBzPSFd3fujb2wWNn9Ogsll6j
NYLjJDO5CCE7WUYv9THXo+joIzmCRMopexdaLRVo/ZkdODSvf4pmfqot1FHq1QdCYciWbBKk0ygR
7Vc4pSIDLAu9x1o3HR0+mx0SiKFFaFBayKs8JRm4PCn7QKANJm7XgN7DKF5du4v00LMRdfHsY+LZ
L0Vne191R4N6bCwITNeoNqxNdAAgvvSvLepWeQDb0iKlar7y8HprXABPobTJyllEcUsAljVPg6uJ
0V49BZTRMwsYCjtvC7ycc7FtrfpBko/Mu/qeDqzOwktEJSOrEfyBXYd7YLUfEMXQAmbXtgawvcMt
sF/GzAB+B5sQ4H14GqOCPrParWwnCAmIGucZgqr3icFzO1LaNXK1Eq2/UCfBF7hT8MA0s/v6DdBw
4rY6lPiM1G77NYDTU29FdGftHQM72Io1fsg54SP19wGzdTxu1xh/rrHnXEdjgp52tPKo9wwgu+w+
aYDnqfnoWf6SXqVdvPEs1XYUM8o1xM3WoclggyHI5TOG+AE2BewBztI9Q/a0WHNS0z2lSDw1VGp1
pgaMEHZdjiajJ+4YAgf1RWd66pxZ1HTTCkHGxqpXwq4hWqNLiiZ+QDGVJqZn1uaxX/Eq1dxww2Jd
eFDIwziMdfDOA2OiaRQnmCUP/ZMX6iXggt8xLkfLEi17FmE3ZK15dk7B0d10vyTFyD+Z9xqx1VTj
c1oSM+9WopW4T7mr8f09T3Ru1e/AcaGZvdEbjU8re9APGbzjd4aWOxwbfxP8CvfSmkHK7C3RORp+
OgmmhIWv+RK9oxK/WPEvR3envhFfKyhK+/g7cvTVBxLYDf8y9DaaNk9kx78o26yAv51SdJF9sDY3
7JSDMWiypTw7lNnF20YTaPbOH21yZ8kat/e+yB4d9Kjh6M9kvc9tsMuYXE5Z904O7Yw6wqNQQKFi
n5XUW4U6zLLx9uatgkJTbZaevVV6XAcG0Z4MEBXRfa8b4on3jA9e53VXK3/xW/wJSRLhOXl7ITDm
oHZMaG9WRq23pvdW6wlV8C+c1hmdEa1EbTDa7Z43OW2PTMdjCYLbw7CGChTZ6dhOt7VeGcohtVl8
S4afzRBMlnS0gKn4HtWKgLC0F9etjgHh19OW0yIapSuUwKvEFlDWsZNeQltw1tWXKFL8Mfp6ka3v
Ueyrx57Tyk1kgeH3Ef3RsItoS21ouc23LWCFsMlRf9J8Bfy61JOIcgjIar0p0RyFeNAptvHHrWo1
CCuIuKqqNfrgnEM0djBWnFX3Zq3jZ8CuYkUiOrz1QdE6bE92J3y4LJATRJMY7lG0XpgdBx1UQfdo
74JIDrsScQL4XfobeXsIaLA+a6svxk5qnd9IG8V82CMvK/qao1DxTdRCu8C9Ke+4Pd4s/RHcmnpt
gu1VJ9b4P4hvT3KmMa+4YzF82Yp5vNOStzAGK6xVbjEo5TnBTLZbZP8lOiA/uVPzV2TGmV+NoMuV
DlocXzg4xknVRcRvgGvV+4fGXQkZ7jnxJcKQgV9LvmFTM2ZFmpWqcxULbKq1pP5G0/23vMf7NMav
/18cRwnO3n/8j3t25TeC5S6rLt3G8dv/4TUS6e+o4lfwPECV/ZgDwdvrH14jL/xdUgFODm8e/d3c
dzDxt9dIuL8D2XJ8uSMGB/wlET/022vkub+DbxCt04BNACjdCM3wP8P6X3iNP9+5MtxPaSzpFgCR
jh5wtJv/DMApTJ9yhSChP0IRKHAKV3EarbPcowEoEwU8l3L//mJifo/g0k/9+RT9LRFs2ICJxUuR
SJOXdRZ7ilcMsquFsrIhLJD1HH/pkfgzIv0tQwHfBuZNVMAI+R3mvAgr9hGXRUXiuJpTfHjlIXII
9aRskyFn67qMDha1mE+1uP+6rdqksBJyFYLuTdAmodwQPZxTOD+/rhF1YSE3QbdK6KQWU3D71FXQ
jmKIxDW6IDvxkQjksIU+x3GZLl1/zCUe33j6AjIMUzptz6kUJnX7nkfWVkgd2jUFfDM5M6KmuU8J
gT/IOeLCJF/tHIhE/zI/AuxwCv/9GrmYY78RlditIbLM+vey65q1HCgVakmZY8OiHAFNC3dlHCzV
Ws6IVSFzpAMEdADHT7YP2zW5nPqBByo+N+BAG8O/h05dGk4X2i1SO0RdC63MfNxe2atNqwiQ+t2e
x49AjZMIZY5y+zzsXZAuM0JJtJqroqc+UuJuIZzw83U/biA0L+PAj+3hYwvB5DhKbiQVZZ4EmgMf
FeRGZsfj6cMmmxa3zm2VfmYyRlHABke1NtDmxDE3O1FJchuUgeV8AOwCPM6GfcfjwC+RQ17P2ygE
r1GiACP0ChI4G6Io5RgGb5TCN/1KxpOq7ZqFWN2sJuD34QkA3dB9O5m0uIsBMtgQwMJ7qYNYfpfR
bsjeSMB6+r8/Z98ZGQ6o+2iEmUhyAzXgccaxDVC+BdupVWmk4fAtKDQ3a2jZw3UBODXcAjD+l1kR
OQ2QEsrSQHN5714Wi3MeLRa9zcrAKeJxMQHAdTppTMvVGdthZZoSUIKhQ/hj5OTpqinS88CCCThp
1VDvubrRCaOGK4DGFEBzqdk7vmg4XusqEYAkTr8ECzqzmCjWxoYBRMfIEDI53zHDEbd0lUAbRDx/
XI+WTIQnQbGw+yeMyN/bH7ePgrtPVVQJGIQ/57hiM64CVmWoka59L1S5M10k1lk1EnU2FBmDZ9NP
VU6lFzFGwZGXSn5B+RzPYl9kw23u5j54MTrRzgXAa8k1+apqgnqKiHj6wNbsr9sb79q+AwYG0aN/
oPnhuP4crSS7QgRYI8xKD8q4X7KzjzT+1C9WAo2f8/MegRxEuyWQcqBiYwr8yKlDo4ZAKwaRhbSu
s6Y12zzu9krqBIyWFGWTa0UJBFDa810LQJWuWNUhXxsF47pWz4SpZLDREoTztcmH34Q2t9EjGkkA
JksVZyXP9nWJy41xNaXo3SPo3N+AhVmLdhW3zCrJOUa7PeEz2xD4iQj1ASoS1+mVdWTiBOYegYtc
kI20VVDl7idroEcttLzNHEOkamBN0FaLfr2pRen8rBxYNg+1cEjwZqpipzXjVFlCaZyKAR8h7miY
yBEcmlWnDlHAMTxXx9g/We8yB9UjoP9u+XJBmentNZUyjuLCJRjC1CFx4kEZkMXrHkEtbZQO0gZF
M7kRAdJl4bacLtJU3vj1C3keq/pu00ArsdgJ3GbIH7mliZsVQYCgCRwmRQY90k8RUsrWRaVCBFK1
Y6VtrOANKixxoEyKn8FrgdJO1Hbi2I11IldwhXwY1mGQsDh3ottuS8JIVuRk3Usje82eZYvyrSxL
1vSHHF2z3bHkYByHtEYr8+1tP7Uz3+MAwMTYVYrjP1W3i3ouKRX0rrmlZzWJWIA5CSgniCwboNJr
jEBdSn1Nyux/qw5HBMZY/Wbf+DnDitgSkU1QKi3IdWcJWeyc4jFL7UgEfAV+E5ydUkUYO3QEHakW
XSIMb4KL4xhyboZe8P2Q5Csin5AJze+r3FkoxZ/ZAOh6R78SzCsnAuHj5/DEQcD7RPiG32zLD0Yh
oZmqJa5Cx+mWyj6WZI3n62I/5wpJRT6A9e1zH6Xv5JfUq2Mb2IJK4569NPLfi3yh0sSLYaW49UaC
PvTEq8rWTbJ1CMSvVhIOverf9TzK56q0fpOLNNJvb68ZMySgjBivV/hq8N0nkgc/rMByWGCbS2PM
sJDCTcErSzb1+jR9U0qxHB5Do5ryZB5xB7OV6/Nwa2Kvo34cr0ClwFAxZTUxk8wicB9SpDBUJ1k3
tWdFqrdgmK4egnDdcaYlpOiAF4uk0MQSukxcdMjvF6jcdX/JlbCPSHRmU9andQxk3KK6B62pXvoE
EV7Hvj3JV7toInuyY6u0UdmwbAqtQHMMIl88IpmdoixYikniE+d2ImYyyVzWpnmLp7yWt70hy/VK
Zvy3CmEOKvHZWopdI2x6O49qm8iMQIGr4gFZqLFuK3tlsMZRyCOb3fj4Fqfp0FDOS9YvsdRjL2ju
NWufQcsEF4BI1jGcNP63DSTkjXYAlKI4RlfVrIrs9CHpxAL970hLCLLVdQBax56SUPvWLBHEzE6y
jNZ7ERk9gIJPy1I8pmnKEpzBmGR15WX+2hObU6n660TIT1yg7jKpAFDTgDyw7wAouFd42hdLNnrq
gI1LLQO0Gr8j0w1gip92KfTltm4rDmVnXiLU91XJw0YNTCkfmDAXiseE1G12jgSS5mYXNZl4d3uR
r8zGWG+HeBcCaHgfI2P6U35SdsxQVfA9/w97X9Klp82t+1/unCxAiGYKvG31jV1lT1huEahBSDRC
v/48r5Nzb1zJF6/MzlrnTjKIy6YAIe29n4779RpPGU7yKfuXE5RLs40DiF7sd3KM5N7cI2JQJXxH
QyhinPhA6Vy1mt3nU/GYhsPr1Gy/qC//9pb+dLn451taObJyWIuxfR90cK3l49kt89M/P7bLF/jT
Pv/mlt48NpcnDMMGby4nKwVOY+pVZbulwdeIPeEXN4RUhbdTt4sj7SW4BqMvgqnbW6Z3Q4OcCckA
kKRjCF/zLY5qOkeB+T77dMN0XgR5UNs04IBep2Z4GtB60nJKZwohkW/05kthe5pWed7ruxwMB/bC
2hxQXAe9a3bW29L3EEWD+/MU+8zBOTIKXjcVZlcEaRL8o7Vjw+p0SoY7WGhjEtbpZsDEHvpqXN7m
85Gb0dzn2Sb1NwXR1x0064a/KyLfRtg2Zn+9uuIx6/t8Z7Mge5floXxA6PSaX3exXfNjuiwdQAcp
Mna0qx0eTDiQKoos+HKpX9z7cIXK6Nb7fLtLQilPDkk7u3CMm+8dTtbXVrT6Bl6O2W2fUQ2Ic9LH
hHNAH9YnJ8tdsUJTFUVbhRygdkRCRwouq0lCvttE26aHLUYrWikU9IjKUwSdmCn4J8Fzs++KKD4r
jHzX3UJDhLE0li2vCC6Ip9I26hqGIS3QiFx7c16mjtxD+goH6YldrbRpzmMEhZNACin6XJO+hAH3
wJq2KLwOI5U8FE6SeuthAsyH6XYESeG0grUU19zkezuzfTP2qjlFtsiAzQ5st66KTcdgaIYVnCCx
yWqah3W/zMlUS9Jld2aZ4vup4RoQOZVkP+OVgoMZ+PmpbVT8jiIlcsVMqtMURANayNOSK38VcR2W
fIwlHpzcTUMwA3I2sP0hNmT3KzLFQcqFNTVcZsc8HA9S8+w1HYT9bsIJyNpibiLkKUGa52sWbuO9
dFqWWJoCukf3PU8hlhsYvwC2TAXIq5cHTbczgn8DhEsl6VctN9ZXqYLMu/eiDro13WU+0wiFSlpy
O8qY30dZED7gfU13ruvCCFiN/0xD78sQLw1ITYs42TJRKXziUFKTQn0ni9tQzub3w2WwNATwKUZY
RrkOSAVTY5i8cOs/Z6RLP/SCQNhrV71r1OUX7Lg+LUMKE5gh84jwboNTrOPvmiQGwNPKoJfi3U63
rpwzMAkEf9c7eFOnejjlC2BaNiePDftWbAhjANS4Ba+ODnfbgHeMnSkqx408ewTYV6vf9DlDolyF
HwqOMtvWs7mc+IFv8iuNH6WNnkEhKOyG9mQA9WSGF6pyYbTvI/gX4qirbLpFR8gZslKsV8KNOy/C
Z0HG5ZJ0nAN4by9zL2S2jsR1H5VF9WIpBF+uGb+Q0IBU1Ql9gwgkf0btxO8EvrCvq5tDX5GUJefG
fPSiv8JkLgIPcVJt8Zq5rVwbeScm/07SV93s1jla3w1YHuohzpkbdvk6q70S3XxktogVPkzFn9YA
qEkZRmP8NIffEx8LAP5znbKizgX7APPzT22AZeYiYIUZ5BM1Xv30zNHsX9neine2Sbo6GvsUwi0g
A+cJe9u4XOgrwbifgzT+Yrsg3XejLU6yxa6wa50sQx7dGJ3sWgGqA1vhMFXQb9nSXVlBz4q1+3XT
O48sZbPwZMfy1MndIihc+8PYAzyOBlnl0wAuj9CQeUZxGW0TGLw9chHgTYRWNsffX/0hYeyY5Han
fHFiMikhz/1IZ+hCe5A0cEII3+0XQLRLP7+4jNdQQ+NyfS0iMX2dZWsHdClHG6W7CShj6uajno89
cWVEgXmHkPksTY2ToFyGYZ2Oi07Jy7hGSDpS9hX7WF2kIlzO4dae0e3ChyL039McdmkdZG5aZO8n
7ZbbPsW20KZQJo2w8AbjBMO8z1G4rqgC4rsA6+KcmMTfhJyk477rCQRWuUfntLSz/WL78Uve0gcf
CnHMIcuSyB2Q451Opma3IB8TojOVP5EWb9rShN31swc/Il+938+mGR8dnzzeN9GiHLY4vI8jIWDo
lvDP3mfNadmar7mN+lK2S/o+VK04esJuEtVcTyx4r2jyCtOxSuf9VrZ5fp8S5XaZJcd28+M95cv4
OAYZKYvCYXtVAfwH2tGNWE/tXERQ+0ZGns3mkgdZYBAZucaAwlGMCVgwOB+8aGAyNMTAmaHQgVHu
uLpzg87mUCARvXEXFoYP5u+J1HO467duY89qUts9Cbk7BIEMrttUNOnBW5ldTYqzoN5ywOCdlcmN
SOIzPjlIZHLkFhkDxpDFwJv1roTnhSx9FH2xs3sJF6jbzkAUkt28rM2XItvcCE556A+e0ntBpEbL
Lnm9cn3bkQERlIutA+dqNAx1zrczwnVLYeC1BvvFuJNJtSD9fNbWHTsQ36ayMA3FmHHOhypF8fHS
CzUk51AokzzalpBvJgL7JNXrvEMRuwsNRPshu8GM5GAbuDJn4EK3ZTPedsstjKGP4MCnVS/YcBIi
MSC/YfASl306PprNzGfBzApZN4F8Jlrz/jVvoWI7W+a2qEzoCAaAdH1ptsJB47zgE6XNGJuToae+
JeZ94Tg9UzD+IGFQ8VjlSoniyrXUVyNGFCUWc9hXkw15qTaMcjCPTUvG/JGtrX/Ol3nADcL8+503
KyK6pcHVKpunCKGFnujYtHNWo/YBR4GoL3bwi62GSL9ip/qEYbfGGHFKII52xfbQxsF69Kkcb0Ww
9Fltm9B1lW02chsQIWF337rNYIvhq6jNxuPS9fmgyy1qOPrGAJE4GayfBkr6dwE3A7RtC4IdRTFn
1YBJAi9dSE13jMdstpVpi/a292P+cTR6PbiCQiAXthQC1the4kDXSEVzDXOgkUJ3MLwUykHbn77a
TKc1EUG2lvHirqc4OFE9Prk8Gj52GZ0OIvHjXqcBCGwpBbUK6ob1VqZyu2cqkyW8sF5IP403Ogug
aEfoX+0YlYdM87jCT7V3kRuGrsqwUyO7oi+jpZG+jAev96GS7yztAXeMqw7rDeaQN5OE+07ftu1r
Gw8oUJoO0Y+lHI96UuBhxdR/SLbtVjmb98e0JUeWg75B2k4ARV+G+2nNp+uGu/6L3Ag8Z1Sx5pgZ
uYcmaQ7ZMlzBlG58HFjb1RAz2XpiCT/KmbFrla+niYUEtP283XkvP5h+Pq1KGLYb+YNs8mellb0r
muxFBl1btgo2jFRbjAYdBeKN6WSQ8EW+th5PBX5PCz9onA8wHvHNreVJdkz8cldI9pRzOtQSAmvs
1HwJS61S+Ugi1Lglx7dUDqiBg7IQyWM/grAYpEF4TrbBXCHVx76KzT22AlSnxr0EGzmsmZjao4BN
QCMQKEPU0OFfbNNPfPVk2TWGQIHAw6i/Jx0Om6k5GZ8s9900WNg40qApYJqrzOeVqfFlgjz2UaPw
vRstki5W60GB8/pqCxZp6mHVj11XLHU8TQfCp6weBs2/exYe5sa4V60zKcqsw7R2FMl7+Ly4Gkm8
n7K5+yald9csdi2IMR1tziabb7o+Xg+Rw01A3hXuGe/eIw1qAEvxYhLqAjDKFgSYzau4aulA71rR
xwdK+VwmC8pxu3W3bRheTybeFR4alSKz69Po2Vj3nXOIN9cZvCe7T6lhVbro7LvJUkwLJt3eyTk/
p93F7iHdozutUoDZyTwEh6lHPSBGMlyvEVHHZSiWfZoze0yjXOEczmEoEWR9W67YBsDtQVZYKquB
pfebK8qFx+NNJlIByIiPYA46OR0KjgZ31QIHdwzsd7kidBlY5UxzSF0aVyKavrt+wMQ3BIkXNHYX
Srg0TPDPzNCUfJnbrAEbcY2rZGTrR9OgEqJd+zmN3VLOTduicLaPRTF8VOPGdkvYenk9Ggh+sYds
0M83DESoOZpvRo0ii02TuyuMauucajfs+yIFM3KGq0zd8bAFEIeBYVk0bNnpKIVCHHBT0mE/zZyB
CA45KOp7TFhwMk4Xu6Uf+wTHZsamXU+wq8rCYDI1dsMu5hIZg37qd1FnP6sNiOfUdC+8aCD8WlFR
bd2ITZyzRe+FmZNjnLW8BpKBXm/g7r1KCuTNDMFt6/j3IZ7NQ59OSuzJWoi7rsMxeZywjbKqm1fU
odGEOUydruPQ1vhw1Ce/FsV4RtvctFeLj7W6dire/IDCnih55LQrHovmwtFAj9m6eo7yRVRdM0l+
LNbZuIpkoxqzssCZOd1wOWWAwxpXTPAU4fjdtqjg6aPB+Abm0zgPYKK7hcUJn/3GrlymjLyHV6EC
W4wpux6XROa0NP0U1AzBertZbGR76UwSI1SHrvgF+gAWrwBwEMMGLWLJJ1WANpyGpHmJB7kgbSdh
63iIWNSbksyZ/jSmDYyves4VyiMainebXTKxW922vcOAn4PoprfiWxvzZaqXJNPXSw8r5cyK6alI
2/nDDHdJtWv9xty17pf1jJ+MwIhr81Yeemby90z6BazxQTjyuet0cY+2Y8CurHtC7lCQZOt7Nsdq
17QdUrOaLtjy90vQquaO6cXmsBl3WXfdzzZtbwcYGtIa25PGliRBWuyK6VoPLDo6s0LoM/gT3DQp
7sV8MxN3FaOg5ZdaotEqAX4bcpZcjcXLoJZ5vspimNdUgSbFgXNaHDrUY9PR+W6qMeFRZaxpy3c4
vJsUq7G43ZJpvQEI/2mNepitRVPdqDG2ZRRA11BiZ+NfVtOadx3StMEi3QRaLlgGrnZOYM4+TIl7
18H1fl0OunkOiqeuM8h6HNCI99hVfKXTpsJJssfBpxd2OzAwupJvXTs+mX5PGpC74/garXl7xmkK
um2CLjY8ROED5WiLXRsKt5OGZPLIfE1p1XYrGrbARnXDwN1N6RzWNu4QDbz5fNyrKdotOfGqxoO+
FYgaIB3d6XC7IuYlyT5uvqi8icDAJ9tw23aGiAdjIDI89pCvzJX3WHe3E6PDg1YUtrz3uODwusaR
3q9L/5H3KPdhW4dW68Y3Lyavg1Qjl/Vqs3NTs55iRNebcc/65DMGHkG1LlvSlcqoa227azaG0w3c
bQIEUuoATyldJ/DeG4jgAgexFYJ6D4vz4TcL2AC209SDVwzrK/Ms0AtQCAQgxsURYK7CrCCPSGwZ
36/x+E5fQapkrrN5EDgtNf51ZN306Ldh2nMdk0mLsBqUrVsZ7ngc3aZj3yps5yBc7nWzsmgvQt7c
dWm6IZxzBrfWoM2ZUeyx4HOcsjJVbirTyVchNlkFNV+vdLVx2NJE0W5dVIrdXeiqW8A+X1Ed4gll
RESlBkZ5ohBwil1noHcFrtYV2ODabjSVStnDFkoS7BMzsOlGUmTyxPHHwm/uS9YKXg9xoHnZriRn
FRYkmptMgQzNAwxd1IChjMFAXl3nvJvMPnCC7WJ8c/VSxAPYSmKzty0fGwx0SAPGDwvxC6NwE7t5
zJLnaXNXfG6RYZIp/cHx8JSZZkUJl8xu3Q0tVvxtsEGLO87seQTLTO/WLPlmE3KQmX2ZRnRhRykn
lmFkxUA1Bl55GylFYKFEhx3Hd/KMmrR9nArwukWatLuGNfQURxhB+TUkd/lmkRUognbMSzLKxT0n
KaQKGH2NVQcv37W2mYWt7vTsUqXTz3MUNtc9zzNMQDpaEZzMVeyhw0ng9Yv9Djz2DB7qp5kGsGm2
0X5g5rwOy+1ioChuVHGeA61v5zDZqSGM6m3OISmkUF1oiHQCGsHicVgJm7FwKL/OCPHQfrQBlpRX
9EaPZgbesOhPEQL0IH9FpX3OlIwxT+Cg3GGY4IKKLcLdLYpjV8w7jz4sG74LwUT/oHIfPhUNgKEq
sh7y+FAEiN3r2bULslDdcRVuqPIm15zmfDRxAxb+PAZl1pjZnxdqw2sCjlW+a5rBKlQLDKtMtL7m
sH/r9xzTC6gpPFfPjBfrybOUvQyM9OraMkRpVjkXY7xr05ivdxAotf3Bx1u2nSPdPqN82mBMFawe
kdXOJd9Dvsl1Zzn6wyWI+3rGwPRUqHj60iTp+mxx6H8VoeHBQQwIgaPFiOlfskU1dr0JQT+9OqlQ
T7d9MEV7jt/yuhmDPNwVUd8eG79ksHLj00BASweh7JQjh3W3QUZL831vMzeqPcbWWkKjNGWscSiX
fIGTrhxmjT70wwr9HXouyIWtRu9kM+zuZQjRPNhie9Z4/BOAbHkQzAefNgC0mdYYCVDVsXtUT8k7
jMPvifXqyCUhV1to6Z2TaImimQQ1Ts+1P7eTEM/9gjWFiUQ02EqGS56gM5M93cXjhgH80YlQr7h/
bmI/Bp/WFfycIEwaIcvFrVTwEt/+dvx3gAIW3g/OVArROphZb+NaozjxF7G+qexk6g6Drw27d1o8
N+4XgM9bwOlyIeB5kJNC1Aa+5RtsMXbjhMQ5IBcAFJD618e6klH/wln6gnZ1rYFDTaAoJcMvQIy3
qMyP61LQtYFQXwLNL7/XnwB4Bj52GwgQ3RYpxSE0Lb+V2/ArE/S3mOXlKpC7QyuLdC/8541Or50C
eB4g9KpiSQprtahqZYwwoCzfK5kup2mBRu+fX9xbSPjHFS+wZQahKuhGb8CtiS0bGVbAiEreBQgI
gdVayn7l1f8WbrpcBJgoRJCA3C+c4J8fHmpKBc7ehSXYnTBwRr+1KxZSZjjN/vlu/u5CBRBRQKKw
coCzys8X0iJOZHzhYCSYHrdBc+hhpXvLZzU+djDE+9cXo+AqAP6MEMj8lyjk3gWI+BITLragL0TR
gQrbDgaGob+ypvgLbQEP8OKvfvH7B3kd3LOf7yvM+q0Fuxyr77W4U80+Ne8a5DXhWFAGk/Jun9NT
isiVf32D2ORwi2A5gZT/lvLXmaJtwwYdkbAMyWJ2DF9cE6+V4mKom6H/VTTV33xjoFxCa5BStBNg
/fx8lwzjWSM2LJOCtxfX49CWcxLt/vmm/v4iFyOoS143rFp+vggNUSmsHT6xLMIQYho5rQlLfmVc
8TcLEdpdsDxAE4Q731vxxAxw1a4Ej07ld3J5VOvXhD2aX5mdvnG8yeA2c5EIYxeEGATS77e4apg2
kuvejVUsAJL1/D3spz4JHGRrKs6k7+/B59mTUAylmJsyM/mR9+l1DB99DJ3exQqPObCIICmG4j5D
1s0/P+q/fQg5KKlAzi9K5zd7C5ukHWfUC5g8RfKoFYb1y6bVycCSrCKgGB3/+Xpv2UsXbBnJWFmG
xQr6Mn2ze0ZrRoZY4yvJbX8o2q0SeX7bmwJd6HZct2m/MfN54uL1ny/7V8LwRSlTwE0jxM5doJ/7
eUmlsZ+WpgBABaPBk4dxNzr87825O3blnSu/QT1TzukXqKU1pHj/fO2/PuIEJO1L4msCzxAgnT9f
ukPlMfLMYNPR8oBTq3bw5KQ2fWym/Bcfzt9eKqHQVmBHKKB4+PlSTo08Xi7zEYlhNAcWBZpLZNDc
/4IqevnK/8xNQDoCnmEa45At4IpF3zDBFEC2wmrs4WTsa4DD9TQjjzmC2NCweoPfOuryXxyCP0iu
P10TRQtJflCFKBhDxZudJ19TYoIMVcUcIQp6c9FhYhG/NF4A6MN3NuIf7GCPLdAUJEPtCceskEyP
fQ8E9Z9f6F/uPkmxxV+0YNBdpH85wZYgshu/kE1oh7slD8MaVgAoSwKBcSSO6ldanb98M5frUexQ
FOAHSrg33wwFuhaaIQZWsRP3cMkqxxokw5fpX5KxEFWDCgkmBKDVF7BKeLMVqBRjixTdSoUhvCqh
Lskq8KUeNQ2eUQB3VR4v9T8/yL+UUm+uGP+8XAtFchkDOqxS8dUIiBlEANQG0Ecw7Xv5yxP6DcMF
rMXkwkQCExjFKc6WNysIDKlxanOc/nqYz1Ha3BLYvWt0xhjKDO0x9sW+1cGe6eT3BfO/WE8ZXcif
/1lQebLm0zfxZ0Xlj7/wh6SS/gZeJwpAEHMvbNJLPfu7pJIkv4EOiHMhBH0Zn9jFGeu/JZXktx+2
GCEUDnGMvRx/9N+SyuI3rNcELxYXSbEZ5f9GUgm8+c3mliKShxYgn0IkBJ1a+uZzS5i0XZahZhyc
63so/IV/NY00D7mL/WszzA3BDG6x37aM6PcqDjaxb9d4zR4yxjDYJkMKS4CNS0DCXqbdfmQB5r2o
A+htNBUIn+SFfF76LoSe0VKvd0706n3IzSFbkT5TTxgN5jVNGijqFwK+HqiQwTjsZZBfkoThE78C
ecV0/7oFXO5rWAbCIcLxLoj2XZ6LKyT72ZNA43XjFQJYj1SGfVCviYTwbmm2sYHiYxi/JZbYCYYS
TqurKUG6QyljkxSHYJqGuB4jmQxPMWni9rQOTIvdZovpJpyRwn0CqVtFxyieZrMnZJ5AeOqK2QPN
isAAmFQWwBS6DUFvGXgazUcSDDM/ubnP81qu/fjZpbMAudcpuJdRkD1cpdtchfWCkc+ZpyA4ncBo
4ZjoJGETlrnugHo0Mp/lLpIU1tVA9JeH0YAxhkRwJJb0qRi22qsGqRxunm0HYDIUSYnBWnQzNjC5
t6huQAbaiu1jqBQgZUvcXC0duGdlnEt6TSa3qn0RrmSACff8qWfZtB7DpmcQZUpqcowq8gwMtR5m
65UFKohxoSEcHoIY23UPk4rFV4A6/lES4ZHCpfvm2LZjTMueYNgKkFf0u2QYYKc6uwkTCLKBebMY
xMwB9G3jvtRNV5h6ZL31yF9JtxjJQLQBRwWIoK/jFeuuijOD+0KnsW24PG4VMB0QJ0xou+KbB3EO
M0bTIgRX9u3wdVkGmu+mjQcfQdHEcX3JtTtkcL/pS5Hl/EYWZLl4hEfBl2JCDPeO2Tk0x6KQSXKw
nuavekn0ee0XhLOybW3h6pH1SmEgovtb24crVubcTU0FYFaNoEhFwfdtS+AtMLloOwBr2twFGmz0
ITFTP5GysyOGb/08sDAvnYqmLyrtGnmTxsV61SVTC5qHasymXnk4znmdL2QEw63gUEykVBXhQYO8
kR4UX2dX9ynDBA4ZqBpROa13mHl1Yf8IJsuAcTpGvwG+nInBcSNUgh3jeMg2CzQhUZdkSn5RHv6A
bRzPClr1FzRH/gB21t9RnvkH5EN43tqvNvQwQZ86CgcEIEP0B0gU/g4Y6THyiLmIxucBK+FWda67
HmGdBMJHtpoDB2lh70cSV8VSyF+kObwdEVyOswQlHzZPCJ7C5M2eJQdItoOFOETNWbtzKwPtqgAh
E19g9LuF1b86zG66L2aww/fpH/0BLgZUT5P59m26+aTf/uTlev/Xkep/iLvUJb/wPx9q193n7dNP
Z9rl538/02L6G5pvaGUvlp94CxdB4u9nWvEb/if6P6hjLmrFH1XH/zvTLrGP8J76kUof46X+caRF
lyMN8k6opCFaufzpvznS3h5oBIokqIEwIYDo+6IL+rnMshuRFqJ9cD0WCd+Oybp5l6ugu8+i1jxl
Jv2VLfBfVuNlDYJlD0EvKMUJufz5nwZx1CqKLZwhGRgnW22iBLzhOPgMo7Vm/6c3cP97+f9nOwKs
8p9PawIrL5hFRyQjuLkCzeXP14I/p4BwfYKgSm8xaMBwkW5Y+KQLEhAgBmS8RMIyUBcBubSFC3vP
6lzisBXRXprULwImOWziXVQ1lyHz3HW+ADcXJMZyGFPWPIiU6NssaMDSClbgJHag/GmechrsBTwX
JhjopIJcF64TIwJ1ilVULNJzsRsCGQ1fXGSU29NhzdpDmvkU7yEO3TAeVWdpu1d9ZJGWwXkz1SLJ
t7myMpfJbZPN0t4PadrFiKPXG7/pwQH9MuMgvDKd19kn2bsB+eO+ze5b2jU3esu6LwIMfhCMaSTX
ksbgLbq6yQqPUSXvW4tcF19gMoRJe9jcDN5xUpRdxoGuAs3HE6wBA1PwPNYIeerXVGaGIHyZCJgu
M4SarKV36dgeL4v6S9sukfigAjYR7KCB7Mcrt80CrOcwJTBoKJBKEl3B7s5pmE455LOHZcIjn15C
N1NLkSjeN4knOw9GROKACEjeg/3UAZjq63HWw/qKk3Adbyh4muo5X4cNqlU1UArTpn4Ml/B9tjpu
NyQNEwdqW9Y1UIWCDUoBSOAgp0MAsNMFCj4+WxMQdhn+QYtBdjy0YK+cexkwnd1N05hK+9AFcsxE
rTFEmFsgcig3whKnIMxDQMyggDWzCclvoDdMPbDVOz9nc/iI0gJm2xdxube7TbO4rbUPVvtJKBRZ
Bb63fNsecANxEdVwk58pXHNkYlEpUs0GgfSukMExAScY3cbHjMxW3ssugBsM5FZ2b6NukbVLvIEN
EliDB3BtN7nXBuBMjfeYqpp0M5JN+s4wCOw6QXjtp7SXx4WbDZY4UdaAdZpJ88X3EKzuJj33y8GH
mrTvZ4NoE1riXwtB2kUG+9yClBl2bbXEjQTwh2c91LHq4a00IuqP1/NQZCOgzXUayiRoc3wsBe2O
BBwfWYdjizgQJXNylwEEwtsEkAQuRtrNoPlGdEUhYSUdbqNU5ORaLG4UV922MIKYeeBYWRUCpXBP
Pcpee2zG8fKjIAyAs4WvIr6F+iAEZ8axNaU7eCQ0ILCnnIfHftNg5HRtlupv4SBAx0LsxdZeWYiv
UenFkfls55kCRKWdO3WTTsIzzHCXBt5ENAbT5WxGWBvOO2u4NRGEk4WfF8QpT0Eq9wN14P5OKMKW
w0VpCtOxhunoYG0IZBnDDxjHE8QHHOPNwrdsSzWXddPRi9lQzC7OXjpQMBajo+V7ucyYF5ieqiPm
HGkI6boCb1h3KxJiSTABA+SFLizouHJ9hk4ybm+grnD5AaSfOXpqXYLluwtAfezfo5h06RGVq0ae
LUkUHfsPTgWBCCpdRMt0Az/opi9D54PuuEGeEdRzEg/4XRBACfyiZ4G+ViiV2SnApHw8mLVhXxWc
ShAS6imMjFKYyXdVXDDY1bUGkUJuCP1TF4mF7WmqAXOOuRqRyOty8Er9SpfdImcKcheOAVnzqJvd
E1blmtUboyx5twZQn4NlPIm2Ay/HFdiiP2BIqxE0Y3SR9P7DdsF4wGqPfF6rIHfb8JGpZYvjD2BY
tAXW5Qr2CUGit0Q8o4HrWBSCkbwbJp/P69d2BEV5zKsluWCen5eRNh1pK7ItQbJ+dWC/yfHdj4Po
/1dF/+dyev/noqgEgvvJdD/VRZe/8UdZlP92Gdr9YZCEfh8F0+9lURz/hg4fM2DAjhEmliH+5I+y
KMEUIKL4jMIY1SyGNjjy/6iLkui3GOAb/lYI1AOOAsW/qYswgP25eIhRmmA6j2RqjOhjFBJviodk
7Zp1bhYYtbdtf7cQHtc0oImHT8EQHrKROWTYWViEQAoxxDCTE5AlVZzMEhSt0PYvKTpycGc05bcm
6RpbbcncKxhDygipV/HkX1H8dAQS9wHIPSQ6scUcDRGiFXcUZ+QUOwOiF7w7Hj1RRYHwoxYCmybX
aAYZi/IHEAxA4owc1D9lY4YNcBKS/BAUWLTR1zHC2+klde97toGy3nhcdgHNDSQAkCjBzaAi20re
fIsj8IFn3uoW8SUj25v1v9g7jyW7sSzL/kpZjxtp0GJSAwBPuibd6XROYJTQ4grIr+8FRnZWkFmV
YTlssx5kWJqT9CcA3HvuOXuv3b0yJj3SdHywnfah8PRHfCDxMod3hlfc1ojEI7LD5qk+ZtOYeAKo
Rr4cMrs9FMNyzjrKGGUxq1jge1YIRJvFMy8izLfEwI2voTyYzhfP/iCjHn6vWdh3FZrHLiqTIZOH
fQquTHRnOrinrEq7sLoZRPSCrv1pDTHWGJWmMOBfjoiKDdSeaifEQVIzl5nDTS/QZvTiIHI663ER
mjNAxJV/4m5onFj8GCkEo/MxD/rj2rUXHUaDdTTAYulwOy8l0yTDX8EMWsb3dUMhaS3thzKvjrqW
T0ixvuTCRKs8QOqdG1JgSD7xm/YykPgS1s+7mrlEy0XhVjyBgDgy80fxPD25dZnw9X6U/gf6O3Fv
vOWhgzShv5qbnRI3ldTavzMyyZcEKDNivGUwZflI4Jg8ehjg4jA33xfBu7JYXybmeHZZnPIOKmw5
DmnTF4Acx/E41HWU+t147FFYUlEeSm+4mohcwQ7ZN/1aXdrVfXSz6JAxcQzha/fjPvNAE1z6eCKb
m4AEkgoD80zqLd8cGrfWaBPRgwoN5ltHXdEuHIbKgy37Ae/F0fKnw9IGfGr7hYP/jdLuicQ35502
Pvl9cId+tzjV4qsM5weGenGebezGA0xW9ahyeVik965auh8jruptUR/cAC6MovIN1ykNjOZgucND
h6BG9TUPTouO3b+4bRQcVnQezXJfomDmoPMu1HRGRo8+1rtsNpJadfkt0uXHaDLrl2IGXrsrOZus
Ofv1ROdr11SZA0AY4+pnpXiT4m40VydWS0YxXMsPBn/NNgJ8hhkpqruetllvsZg+N+20I0Krh7yc
Tvbmx6uRp7LDMzO5JjlwjVDuoZ0xJqDNTFXTHq2yvPEEZvxRgLSSHMKnHn9xE1y8ojtTx93R7U6t
cMGWVIb3syt4WMu7OrPO5tBci1Dvzgz/MRiWC6rFtDfXNvYzDBTmihBf7Ol6RACtxcWe0Mn7HnJf
xWkGWx53iG20F7pdxG3Jexv56kNt6OjR2aCrqvF2aq+LZecx3VUmfMX72t8CLC3DU7nON86YIaCt
ZvNs0AVkl//uU55W8AltQgM0A55oNfs4N+q31ZREPdFYqdy1ofeC2kGNdTKu2bkgeWBrZIIAJ+4h
RmEXAd6JsIt+Jfybh1nauE8gWPZcpAY2atlSGeEojQNRv68s/32ruf8y+8WrO3Q+EooGHz3MrwGz
ycpT0EyZKzlUxAgTu8elpSRZtjunByU8Qrw0ohQZJngCDFEWHToXKXAE/6L2OdE4E5hxFoYRD0jR
/FgGvH+of3AsnS0mVjVDQat98krga1JsJYLh4uOKyc3N1gdbof/tGHoXWSIt8yZcczwVNKnc6oIB
h8tT+2epsB0AfwjjUK/wLBENOtMYO6bQcdh7Xza5c2hCPlJk+rHvyzuTeIKlKq+BYd3h/rg6MiK7
sP4umcO8Do70Wbnzo62YiCgYx2b1yTWXtC2LS4uoU7gbgXH6rnDzBHHyEsscpfF8Xaee26kTiTt6
RxyP5A/KJ7Nxfmxhf/RWajK2teW8+s4D9WuMB+IQestrUHNkalGZqQK27ehfHFOnc7FhTpmZBFl8
NhWFp8wIrjoYn3pX3O7L0YJl18PPeVnc73gAksmDmekE3xYl8E2ARS4fPbBvxxV6NMkJseTwMEhm
2pvxY8lwaixXdwvOY1jdVs5a8MRIlHhcdme5n83iONlt/QCp6pOt2pjDexsrVT7Oi5Pk7ojgcHtX
Dh9bMaB9LJYzHetQEq8UlTdZbd4JbbR4ZtpMxZHVruE1WPqFBZFQpDop590iSYt3iiDiZv03vfj6
YzHr4dXGVdCdZ5nlGw4iJ3pymmomoaZXbC0Y2OQ3GWEUWraoeUWu1sB2nXBKQbfDF7pxQPjUM0V4
lWvrfVk7Xhpvv1zpHFaqu8WLY3KYqjVPY2sK7yHLyENIBquLvjrtvLK7FXb0skbtZCVtGzQbjoxC
fVH5NoZJseZzeSCrwe4PBUnX5bHxK3KSEVTPty6e4PlAJEWN4HIXC9jDIm/VzCgBgcjIR5/MlTWl
GXiubzkmtd9pCs9fA0eaxX3kh77xqV9FQY+y0xNM5ZnUyjowhvFUhC5oKKgiWUiAZG65abfW2k35
XyZvsIs7H7Wv+YzURaTBiMwTDGlBJ0FDrgElB/NEEmfTjlV5qc3OV5deB3V4Z3WtR78Cp+pTM5K9
lmJc2g0OvgHSskAHssSrrleQp0CqrNutCkv/NC/oFnYFcLGSOhmZ2f2mNI7EVpqGe1iw3mYpklZa
KjbqM0I6842MztGaLOKxCXahFeb3Q5TmBizApC0iBIXdMufFfW5RUKR8Vcj1Z4XRr3KEaq6uNZhv
KNbM5iDCtqyuwWoHrHplOYmzWnXxXiy+spLCHpQi5svH/4CRdIC2rHJrOBTsGNjjwHRiFUUw+yDo
v8s4MylEzpiradNQ5vn9IXKl6ZzDrRz71Jr1Qk+lC6Ov1qblxNuCvxm7K7g3CG6d4vlsrA0LFqms
feLNTWDf0owyNo6OmbawinZVcRxmT7MYAA7bzka2LdVhisaMoJh+guQu260CKIzzAVrYFm0/mK77
7QNJ9xuMFVbHEk1y6CIMhbi2j1Yc42oEkzc+DBFZhlnvGyKuBzl0xwEDEtvuvHtHuzpb/UPu0pB5
8kOMThcjAiG0l62Rja/LK9W7hkEO2TWlhyI1XJfRT43QG4kp7bPukRt5G67MElbz6GVgbnUoAd12
ooe07YdKD1AD1uoVH9cwHzb2Gezumy1fI9lMqEZ35x2q/vHaQmXEoGk6P+0luPOP66QavNGLnm4G
pNbgGiniWVdMXS4J8bHC482aY5PgoQ8QCfsL53ht1O4n2VXokat8MvESY7IBcs/RPXWqyb8ZF7Tp
8WzU/u2MYb5KTXTLI/DozJ3QT481XZlpcReaX3KjlkH3iwqyHAp2dSpgftI63ZCKJdDL0QlnG70y
tokhpUVGa0NFjvq0jgHtlQjx+UyxUSEiCqusDlL2Ics9ZO5KtYOjCV/P4hT9Xjv4C0aqXgQSP/LW
f0PtM30ZnQW0sRhHUvYclXm3jO6G70rkDqRverprUnYT+RQuDlVl2e8FXW+mboWPp6eit1p7iHVA
NzfteWyA36b4AdbbLZ/nV9dtgRTYGoq5pao+VdVsf/GG3sR+kiHpSofZKq9TnYOFho3S4N7NuubU
9m1ZntALGk+r3e6+5bzP37zgQ84dkmBuHr/pcpy8e68ox6d6wouW2nlDgUUsffTVzQIsaf6m14d1
NXSbFODRPlSs01ncVAEbtdGMeRbzBfvvg8F1vjq9xk5o82SAzDbn4WvYhYy+MiEJCm6zXYE7m5lD
ZWKF5oUWpmKchgfr42piBkuomfy9s2f5jDhC54eXzc43F/MSzWCxOJ8Y1HkVtmoaZikpqBN+ubrA
klpCPYJejbr0R042k8sUc7LXIyBc4gfE1mOgGiIN0TP0RIdBt+6Dd71yF2sXaKuvi+qgywfzyOWj
ZTnpuOpNLpLj2+xOZsSRybHXskjwXcY6aJp3jhSiTWTTZJJudtQLWuFbxt0UROzBYq3qMbHbGVSU
6hYsY3Kz3Os0OCukia7P8buHNTaUIQCQ78MeWVKGo+KpwJ0DGn2sik/Cl9E3yxh6noUqGLLYW0Py
VKq8mLAW+dg/joNdLO8a0+2eOEqPn411Js1g4EEuD4xBabZxICwCUoYYLPeNlFO8ZbaTM9G2yVPG
js94L2gnfK4MrDf3sJk9BmqsqAXM0zXqHoYeR0uiYIv5CaA6HPqEfZTuH1K5/9/i+V+7BOJ/bvGc
xs/fvjco5L//efi1/5s/mjyGb/3tJ2aRpYGARLyttFH+6PLsfxSajG0Dx7RtBFy7Iu3vbR7L/xtd
H9dhQmOiOuaf/aPNY3l/Q4gE0Me1afTsmUT/Tpvn1/HXjkykz4Ocw4lsXohd5tcJkT8wN1qpxFOU
+q/UTeSTubrEF6oWurN/Z6czrfzvg1z27tSftHF/vJxn7dFwFipgz9r//E/DLwk7gEGGrVOJ5SFm
pBzqA42u+VOOVfe6zUrMcRlWFnc2ZsdvdKmH7jwA4riY9abhb1kl5WEZjPabtKEelHhT3lWYNcw4
kniFdzoDddL8TeCWYN4ricP2u8Y/sUHRhFgdZCS5Zx7pKYV2XIrySnujuzYYJp7xVA8DpUOU4FGD
K7O05sVQqr7aESeuThinuZj6ezfIjPu1RBeS6tJovraQQyLOx1P9NBdFWMdONFVPf7qn/ptJ3s8R
9X/p+/743pgbcfcAIuJq/daLMyDyWd3G92YtxvIlmyp6v5OhSK8wGULZNJkHZjn4YmIm+p/4fy5H
I3c/IeJxwu6II4a6bqucFBErp9Kg9unERarPX6qBVPSoLkuV6KbE1bN1bJS+J2rBmWQacV1gujxY
CHe+qQlK0XEcI/86i2q9NKKikkWhcV5MzU4S+FV4A7RsQK3qGLc9vW7E/yCg4tJR/Xdzk88TcBmd
TMyetqw0Zfqvv6jfpKw/vygqLgCvCGlt5IC/iS+3jQRCNK6kLAKpi6cJw5gX5ppNDkIFMxyrGm4Z
NBgni2mZtoBHEQt50EVr0k2y7JvOWpb3eja9k7FS2EzQf4CWmDRC2vzUqqU5/MUb5kH+/YlgJI5G
C4bpPqr9TQDb5MGMj3+P9dpHEbzp7Dwt0cdSZkscuBzrPQvLurMAfO5KBnftFpHoUMvp3wpu/PnF
Icv/KciG/MRy8OuTqRsPhKGXa6ZjkIRwrBP4iwfor67P/mt+u5F5GZ9LwLONznn/Ov60AFSVEGFT
Vzqt85xwU08uabhIwjhzVyVKO8sZDLZ/4P1yUN7y7FqriqZFD8bfarK/IjJb/7z84Qygx20henRQ
X//2drw26wIGPorp8ipubbyOlxwN9owlFldmVsztE75gzz50rR4+V/Z2XS3Pvhlr2T0ENv78Kdy6
Y8VvL2I8i9kdjmYx/YUM/Vcl6H5pcAztEECa+yj47N/u6UWLAByQqdJt9umTRuXdZnVX7c/mdQwJ
ONL2Hzflv7WZ/0t9yp/lKf/5MOESHuX3/0DIov7jOHbfPmuiyf5f0LTsfoT/eW+/6M/N+udtHZvM
/93XrRARCsYFk3H9z6CJf2zr/t/8nW/PQ412xQvw1/xjV3eDv7HJkotJPiZ+GLbWf+zqjve3PWFh
Ry/6JGbs6vR/I/ri1zsm+KkQBeBoAt410UX/boqi+yY2jcMAsrOeb6rA/OxH9LQbbTvnzSYQrfCs
4i8WEAIKfn9ZGwk2Dqw9ExrJCGzHXx9uvEu1dC226SHTansZwMt0F4SZECKirIqAo0wK+0afrVhG
IWL1BLTNmeVhT3WZklad4ckrmsoG3eQkQ+eQqQDx44SubCNGZ5bYrgP7G0NfK8NQSCs26WURQVdg
kGO+hU1Pe2CIpKDfr4AepnSThg5OwrSkNSISB5AX+tW4GuzhNc/H9RvcGAf2I6DNNK9N2qFZoKaP
E9vldJzdcrP32e4sH6vVHN77VVVn6TQPm39FOcum4inyNy7NFrkfPWPc8pPBQrDy1pZ5V9eF8B4P
nE35DF3F7kJfy5+qBGAwcgvEdzgik6UGXJRa6BODm2KafAmfKmiIELOlpLEA0Glp34HFZJjf51N0
wlA5PlWFZT3YeY6HmbwO861tzQfOVgXgIU6ad8hg8O1Kf6KT6szBx7ZrlYuSVLn9YzYHfXsku2Ax
3ivHWR0aL87Y3JpbZgKX8qul2tEH9Rs4G/91QSN36Gzpu+gx2uEtHEL5YOK+/zIqt2RzwqVLN6nc
+KD9vCs/LZo/7RezV1hdXeHxoWHWIqcMwXSHCS1Hm35+bfBz6XAUH4124OgnTIzolGIzZD/beT9x
biefqGucIcn8XB8QJDK+glHiCPhlkRgfy3WdpvfIgXjNDAbQG4IWACRiXbvEUY6Lx3sJtmsFguW+
VspwryHn6OfA7bHqo/bBUr6qrPpqtpqm9FIKrzzURmP7p8XRqO7FttGWitcWA95pm+xmK4i1xfX9
ICtjmr+Fjlws5wr8ooKdTQ/NHK6rObb9ET7R2CbjHoX72Jr98GZSNKnH2nC59pNLF/Soy8YGbzMF
Zd8/8NKrqI4yY2x4MIIok8SMWU79KNAO1yeEQtSaib0A5zmxN3N/WWiW1RMkLUZ/kLv6fYYwY/md
H1GEdtVLy6GyocyZ0BTHfr3/bbzranTM+O8/DDcGLuclsqsaUGDEb6b3FcBBk3XokwLSIDiG6GfN
mTdtaRl1+Xjx6izwP7m5ka/pmre+Og6BXxivkpYokK1i4m52EF+9gZEkFMYQc0vK4jzyqTtH8Yf5
MIRPAH52SNykhHpbvcXt0swv+5QnpffSOaS/c0CaElFw47oEaDRKbZ76YLHql6mRPCrmsJBSAUam
qT4EupD14+yD1n5mT2rVQbYl64ZWITdkFUVlyRSmUs+lK4zywpG+WlOYf2HwlWoMZJS/jMo8dRBI
vmtwfD8aaUXvNFgk763AW77LcC195ERzrWsLHkC+hR/oldXRcfaU+5yLMrjv8dDfibU5FyhzBRzk
heNeUghZpfiNkPJawalUwaWxRxcff4aMy/Kpi3PvxVn3MVzOtdJ7Zp1o8kRPY/AY5X3zKDzTSEao
7Bx7tnK5cWor+zCh4ZAAF4wyePLt7rlz2h+iz2bN8HLxTmajrcu4TR0JdOXI11869wWrMfaYyJ3f
dxYrYVPa/Te7zRjrIEZ7Qll2rpdSHjkYvU5VBFqiK9x03KwPQ9h/b7nQd4HQIi1c62wsszqtYsgu
QTd+6XT7sFuND7YGSmVmxnsDpRet4YCZ2H5lopXTAcL8KzixVBjLy1zq06CZXKhi78RA3ribFKeU
cSJFj4aUsZbWIWKGBSunvw+6jpUVfO6wEP1Y3kdV8SFsnUPpAtVoclsfAvIEONww5bByy0nqGp7N
CsLJ8RPTyq/jFp58sxAUSzIFye1e1kgcG5ndbnYYxq7LZuCM203eK2wK1taesJlzhzj6xtENC9hY
vWP3mlPZ87jmbnslu+Qx4/R1ZJnyXrdgfXboWMFCy8WPQI1nDwNCXPZY87PpE1K3PpGdl8dCuDq2
fUb3Vg0tK4qYy+ejcxpJQ9yiMHX6MSXg95sdRhdjt0mVNtxY1a5vTPpwxGV087piNs0YB/VxsIxb
u8qfnahCfQXrS0ZrRc9WavhUYSvcdCVGCAj6VoxHc3LCJ2FGxMM5QMTc3L/mdRfdj5n3xKSWUrfl
7sEZ8ErewBM9TIOxY3mrI+8Mk5TZUJ3f22XGUr0wgMvd6pQPKzl8tb1eLG/9yNI5J6ZXH1Hqi+XJ
UztYo+7KizFEX6pJLXBOdclpHB4CZgKTtZDD2DY/RSGtO4t15kBz/smSm1GluTZFLLXSE2F1a/d5
1hvLEF3FlrTHZQL5sXkZw1gxicPgN/NpsjrvPHd+9bKakDZ4k5iYYkvOhHW6fv4RnXfOU7CpcW8z
l0Na2GN95XBFSqQOrM+RaPNPEQgLnzGhjOqDtQ63rBLrg8QSkfYNEv8g7CzmcHX3uciQvx3bYt3S
kfwnjaSRb2uReZoHXn3O/Rqnm6ycoYIHYofPahjhsSHTpBmXba5xUHPUH4gdKO+Q5Tesg/lG33iZ
1NtSaOvMoCn4NPi2OPQ9nomaSpEtoZ6gYy2r/zBa0Wdkcs0hzA1sfuCfmvpkWXnvf/FqGq63EWhQ
2r4jtmc68xSHcRBOw2nwGbWChfGTfDOKBwFo4AdwCTuN+h4XSb8a5evOzk1qO6toa8q+Bt5hQcdg
xirs8sCkwmfCgni4QJ/brFxwyrdXs2r0fVvmUG46G7vCkZgH0LAtVpHUMDs+tD1nRppXyrhvYWdQ
Xg0yOI0TQBM1yeKBSBx1ynAHfYkgY503kyNNWNdBEgW5c2BmjOw3L6om8ZcWPcpSkX/UoCRmmfWR
sHGPPjEtUaQ8wmNJfQWz+86yUdE0xcQota8VmBRZi/dCrNvZ5qdLEmY93aRysdPBUjU7PFLdrzgr
15OjKuujGCynYfVrmi1BeIs/smvGAudk5X5UI0KPuh21fcynnSLVitJEZhudRORhaWmFPmeuRGnQ
mgsMRYPlBQCcB/h1du+sSgTX3G6Zwi7Ba9lIMEMKlXBsTupcI5O8L+kG4g/yT4ol8AS1EcmVdAzr
WSoiYdlOu0RkUHI2scwnMLHOE3wuwnpYK8+avKsL/MmG3NDAY+UrEa6y9d0EwpCnboTetDgNCAY8
T0haav9poq5+YqrIPCoX/o32UEyYS4Pgal9vRciUA9e17A9VG/Q09MHX3NESN6++Grf7wi7JmjQi
lDyHPGvbryJUqj1UauouYTR19xu0kLEHv0akeVejlxwR8EhH1wGyGEk1lftVdrLAn6chVvwvKyb9
j6bEN4vgd2guAb2S7BwwlUyRI5C3abQA36Tf36iAbs0yzMV3tk/FeEzrGXfYIq9oKOU1xDvPqJ8B
Qrt68xNLDxRl9hvvVJjI4GPA/uN5s6bmNMFjDuF+ljLVTlDFtSohjDa1ceSkr1+04xgT0nBjPVfK
hLubV/RfGF+8RRxq+u/k0fm0jbQfjTcTA5aHWkXzh4ExhnscWjQMceMaaGHWINPvw0mEd44MLEqX
ZnrH6ZFG5gYU8oQ0iQNZuBCmqhoUbfHqbj2BmKZanmfTQnkcjmHxw29NbumqXe1POTyMREk/rxO0
L8TCu3IgM9RoLCJ7ZzM6wf4KCQleMJRNoiXpx5nWL8NsD9UxggRXJBKs3YM/k/lxrfOwlGdfe82M
3iLvgxt8TU/whKFoLBCc5UlOMrgWltM+OyA4EkDo6joSFXDt2obMzT6sDvjpvg5CE3O8aWu69frI
QAtQF+LJWCApI+fN9gYtUdUlrKrarHMjbvLZOm6uygiqmljUsfExmbHLtVoTdIe5e5iobPKHgssP
CRAEVbJWHMmR7hd0WV3Rlid7DGxIDrlFTIr3WU39+q70dVMfocYoL6XsArmrh+Zuzjrjolmpb8di
BL86lR8yvyhvWNWR4bebdz+VDFskq+YpCoV9nEYvu3NZxR+8HS1vh6XBnp+XL9iauiQAgHiAmVvc
TRynmeQ57tcQhuMrjkkiTZmyPhmZWZ+6PnypHKwPqKrqW89ruxfJKOm4DUt50GauTobb9efMtmUO
A2Md0robRYP0ARTbENrzHUoItug1MvtDX5YU9Rt3M7I/FiexvGNo6p+8DiQURYcoZFo0mRpvPA6P
h2IVBJy5ljWgj8u802KL6UIcjaNvzSIzjntn4xp2PkFhPDLGWTDqOiIdWuLQ4eV50ZJicIgGhoHO
2HsffBW6SdZxxq5ynlqEKDabOMJ+TpCYzTOAX6daW/kjqmv/2OJgvWtEx5wSkNqPCu+fjLVpbg+t
KR84LKooEbzbQ9RMbmLSqZ1Anxs1HXhjjG6yam9e+7pHUBSSGgg+3OVqDeQSl3J7p5GIpzjJfGJ4
GSs/+gHZIFgQ85q/qgcWsNyLkFdhGS+uYzP3SyKDZYMxBD99zprym+i39dCO7gBVoXTlccbuoI+d
8J0pIatmvyE5Ut7MwRwY6M91f2tg3bysqoWb7jdwj3seeRe/2Rd/Hb3367xu10YpqALmCPVzQgO5
Hsy1ssm75TBRxgysJwbkvVmnCyO8VweS2JvX5IRIS9d5ZzmjOKCKzy6MAIjBGBgHxBLp3PM4K7QZ
ANMgXTD2jH4AxK6e8cR/b/OFXXfKqXcLW5FBzZXH7aBoF7xCXCHj2q4G56s0wYg6mg2OMqDhrLkU
oGsmXQ83BWk5OJbL6WjIAgEZKt78IISZJ0ZZlZDp0I4ceeUiwQXUprbO8tiVI1ROb1SvbG7tRc3S
uR+RDJwlTtw1hlI3oMGA6/o+qvL6joCY8rn1QZm560LW+aA3vv3wJuCyXGHb1UfhgCw4ZH494mFk
jWejMOvqW6NIaZ2asXS+rqNDFAAyTC7sGnwpIa1dB28YAOR0BDRLcKeHfWxrxaquy5W9OJ+ftMzg
5zZF0C6XcbK897CS7ek82Lp71RMXPcF469zOtYnWjZNzyYGPYuqmXoXZHLcG8Uw6Auo82aLYY4sw
Qj1VNsefQ1bb5MRbOQYV+jNtkdrboICRrJVuzoFdb+DvtAq+zEM4i9say02QhOu2OJcCFA3ul1V8
No12e1nMcfee9UZEiDKaqoVvrzDk3ewS0pZMNWaYm7peSU6rQhIj/IHihz3U3M6SivMHxRlpmn0A
jAxLrFHe2crMx9TxeMQWp7Xe6ESZ6DO8Ob8JSgiXog2e2b+J4zKJePg2j4FZkDgewSze6lV9rgkL
vUKp5eid/exleQ1QWtajARrz5k3FZTaM4Am7+UTQfeuDcazhtsQ2ULQiEbRXzqBhAVHocpiuRriJ
Q2GZ83OpjQBEuyepHyOreB2HsLlWjdVaCfjr/DOGX5oIjB0szkjZZNBXWObBaS6jEyLG9u3WOxab
RSfN0AFdgBqUZn6wAoVJO9JOAxO5BFyfYkoraUkULh0r3Vrlp4UpWJ3IsafrUODLZv9vIeQmtvQs
JDS4tgc0fIX8yr+m6PcmSg2rboY3EOfZTaeQk3B0qOqhPnBq45cMHltUCmDPJFJiCFwq+xWthgtU
/CUEQpewM/HXeCYdbt5oIs86d9oKaebPn1c/e0ze3iexy3antOXXPO/yNY4q324uZQbhBycOetCB
5k3WjiaEMHoM27lRNj72hDbg0D+0RPjxKaxqM5Gb4Jxrb5pomoM9KWemxeQEg7Edg7avDVi3AO0f
/Y3BZALXe3jrXI/vakD9vyRzmPFfq2rt9ob+tNm/OHan7JDjrtO8SMiCkhPZgBJUFyO7kFEhySJP
YhZOfae8yBZf2i6g3dJmdFP/3rahV8WXZKNTqmhhyLK5LaDJeShQA4Y4UevM1dmcDXNJECdUyxOk
++HN8Bx+ge1VfH1/9HGcgXr5Btmtp44zivj64A8Mio4++Qk0UPtZ1Ad8ghbZId4maG/NkrwTchsl
H0krh9+vuU50WZFf9Q+GhTczpqlmtTdCila9NYyoWJ6HbOtfTBvX/RPLJRQ/xbC+vjNcyU1ZcFDH
CY5er/KSNaxGkIwsPUTcj/X4SuGv9IfOB17/YuGABurZB/2+oeWZPo2mG5ArGQ78tlZtvFE5915z
jzCIdxWGEVJSWn6GAF8GJ4AtXXUQfxQrysR7WG7CpUA8UvkOLTpGWJmbzAaO9gMqfD7i0ri8fdse
EQLOg8xP5bgPwJXb3iLg17GUi/uhXEIG+WhIz60HN7ALtvbZxdfhx//btCGMLzT0415nXhBDS0Sa
PtC5HB5c2ACkaPTKe/vTEOW/GWb/OnMDab9D6EIX426E6xco2K9TgmrO7cgsHe5a2xEP3eKUiEfb
CXkPqCiU0Q5xjvovRmj2P73ojpmyYWMwEmYC4/82mqCY7kdN8RT7CDbf6NRNZpJxN3yXHO9Se9w8
6N9KYDGYMFFx7sEmBi4RO52ea/HUzG0F/GgiLLAiKRY9pNkeV0d4nwQ09Dn1Cmb/iJQGNvtVO13H
wUWHL65vTO8DUJ7HyBLWlUAXC7K1X8m/AgDtb/+/xqp8pzyZgLrgfGAMQjXy23e6GfZgsX2sMWfg
knsbnXBe1CjUHG95lLM73znB3CVVn4vnf/NqMp3cQ3bh4pgOYJL9i//TQFfwqE1lh5t+qmwKy7rx
L3SIi+8F/k0PZZZd/RUj759gRzx7TOKQj+zDN8v8HRom8QaPU7vLpdsGcas7AVbwjOi6VLDiYwHJ
6ratRfCAPXO4digjY3r1CtMqbFLjaOgePVhROPb4FzcZTq7fLkII842LwfCP4Vrw21fRwRetBRt6
3GT28hi2pFnCdqZclNgyq/hff+/7Ff31ioe4u5nYIxyweZp+u+LRmvnMra0xhpfA4apoBgco2pK7
l3/9Or9/KKZ8zNQChCfcWRFf+6/Xd522quKZgoJqKjrr2FDL5gBbF9sTrQz2hn/9cr/fyLyczX1k
O0xD6flHv8264ZeXHetRHw8/Nx4wEcwZUGLsyx/i54IUrXVvQrEx0EQmKeYvFQo7p+CXb9binmKA
y8id8emuDPj1E5ezXWL91kxWNi3G10I1m3GoXFf7TBuN/IGaw50OhsoHJgOFqt+yrYEw4kGaoaEX
SJPmoJnTMdEMEO9VTnJ3jMyAYBpt1xjVnLAqkdVqB1myu2RkExAdWcyJQLvOGWOzsWA5FUzq3ihW
uC4s0U2MwwQ08ACCCUfBqFn7/xjBeMBg1pSZwV6DunD9H2zddpLuvwuvuTUW9SnM4UXfdBSy9v3/
Ie/MdutG0i39KvUCTDCC8+0eNUuWJVnSDSFZFucxgmSQT98fZVcdp+tknvZFA13dQKGAtC1taXMz
+A9rfYulg9/urNKf55O+1La+KSfDRYyUEc09vQUPVLY0bAI7EqBZVI023xj2DO+8GuK6OmB/Xh+9
U8z/N6PVFHuicb3zjsC2T0mEvnLTweuCwD45ARECnHjiiJxmfRLnKdWAHCt++KbX2VE7wELZkjrJ
S9KaNibgRoRnVa8YBLvYKC7ysIjebSflUcl7nFEDxGwUzgbtx/GXOoqxyfRpmj4svV4+BdaseZhK
lx8BKhgbKMnkvbzI+pYHeknIUHmBWdEAf/PmefjmlS5VdBOlg/XZ5E6sT+dm5HGPBx0pNbdTLnbN
EmYYnJ2Q7+NkTJL2cunqeeNGlFSAZFKqqMIJeaOY02RHy+S8lzGLG4JMVGJpMpzxFTGH6jN2dx/1
CLoqMg6BE1jmkDmaUSriUmOfaDHZFTz7qUKXhDCNJj+a2w678PodhszlRQZ2MfmuURP6e5MQEoEW
Xny8CQG/dMDKGyGr1fDDLtT4+XaqxlTdaBO1T2rJAerheIiZNE/RIYNh90U6EOlkbrPXmK2pu4q1
rqt93OKQbGMrfCHk41LlNVsFv85nbOkuDSQxdrN19r1KM4Bv8GnmaHitDiO+y2TzXTSF/DQnhQBx
AW3M22GVX8oz2iZUu39/WvwiOICVyFFBCYV6Ctysv2orf374RLjbW0fUKPlURk2fsD/8xO/IORW6
sWVvRZde5eHAG/j3r/vr4Qujkfh6O+D1JeXEr9WEnOgPY1Tom7KMON8Ti9HyrqG7vfn71/m1avlg
bVEvIczkJcPgl9OQ1VMaSaaHeKmwgDrgIRZu3nXDSzrQE/Y40hD+/hXX4/znxwq6BUZoq0ITdZaN
nuPP7yiTXHfUedNvXMcKHlLcOd9yG6H0SZpHCPwk8KpsUy62HZ7jpyU+ktvw/e9/hH974sA9Q7UQ
regSZCS/Ujcn7iJTFSxflzSLrs0cT+0uMQ4hbj039d+/1r99gHgtBFZ+CN2TEORf4zfTIakJ2AoW
hHdN8ephhe9WAxx/EI0kBQV9aN6+qxt+/3V9nxIB+zelwkeJ81PVtESztCAisw6bQnODJ5V3lYi7
T0IKZCWON79Vycwn6+9flRvyl8srcXKjSPJWaTFv8K/ySJ5FmItifLpMhMpr21bqbHbhJ26Kuawx
grqN/wbyxLx7WSPePEuT1SHzkIzu1Mn03grn7k02OVkwyEW884LF3rxr46j8FFSjc79CxGC9MHQE
eT/mDxHr4Jcqk5jlsEaFBDUwdOMJOM7MF4m5mDAqjONLmYWraiaLzBkEa3J75BTNLwS4AK23cqvL
Lzg02fx0WI8nHVvdcRHSnCKPqMMbCB48ReasT7LHJgorrYFPd2HkbHwrqJxj8NH2Djyv8Tey3wL8
OVakm2lGVcO3SGpOBxWH+GmmZnFJkfJr/KNoXjhMU9IWBwTFFolJ7kf7HvUtf46vhcei5VDuX0Lv
XsIbd5z5DkkJceHK1k18WwTQ/vVmmbRdnQ1+vMZuhrpFwDNUFa0ojj2+Z502kudZRCiEwrGz41OK
XmRpOc5L1n6X3dhX4SFbXM6XGhD6tWJD/9l8zGfSpCdUlFXqW64B5TD0i+xr8gQ1vwhKGUbBMz9k
lIfmiIMCO61TI60R9Qg73/FqhCHw6rdyDm2UlwHCtAuSohgkewUmezxLZMU0bT0zeLS8+EuWgoU7
zNUQEf2ROI8KJMeDF/LA34WWj8PaahzvvO4TDJdkSIbZvo5Cdezz9aOtEcSdsD8O/W3WxDyZ5tzV
LlZDwN3nCiPRLsKIdf79qPYY2vXcGLFVXHyf1eRuVqunNp3WSxVhEj1tCbNYTr7/exY0YYLqGPbh
BaENoXsB/qxYgx4dAhR8055oMjr8XVEq68libXLnonRhqAM8b3lGmVKg+rUwBI2thTVZU30evTnC
KDlHkz6UkYmrrb0MQ3yZ18yFD32lVbdHh1FVl9mk5nFLUKNLICwaG2uL8o8P83cFytLP/Mh1rZP2
6Fchg2TSaHzJVLpN7U3PPYId5+Pi5n3mrNEmfRNhUTfm+Pd3/r/f9x5VLXYctIA+xP9fWxMkcYQg
5N0ahoabizliYX1qNBkMrx8v9FvS0bum4n+/6j//pBn9S0ba+kL/t5HPVlXwX6tEj8P8Ur/8SSa6
fsEP+4fno+tE5kw7EXoI+9Z3/r/sH/RuPHSQ93o+LDCexT/sH+EfRAxLJNKOTdMFR5e/+kH5EH/w
BfRkzCZWAJoE9fsbQlFvhYz89MD38HMS6bJCvsMVkMfJ/OcHPiDzEAsqK0F8zxXHduQE9VYVjdtu
e+OTWwZje3kesT7dL23KthrHZZ5tGbeleoPVdPw8EQOGnVUUzrNKw+zGRqysNh0Bs3dzsUA2Wojp
3SlsFp0dt7dTmTAv1iiJYIghWjx3MPfazEjH5LaJXZx9Vr0UnwbGNRcC81pH2F/vPTD5RB/EB5aY
vpBIGm8bkFRZckwKgjvUAhmCsDCeEhzxyaOyB32VpVnm7BQKU32wdcJvFMSFegRIRwyKi3Kq20tj
By+9OySf0DSxaU0Z9X1LVLowgWwSZ+E3LPphn0/AwaxeqRcUGuQizj2RmBtvXYgdgVcF54Qge/B2
pKUBXJWVz+gNnwhqEtmEYudPInnSKhkuR00GDZP1CF3YiOflUyro1I7Aw9RZZYfWsKuq0brul8wt
DywvmT/JLkIbVgRMgDecvrCDaqc08XpdKu+0XWwJRtMP2iscui6QUc8ET8JjTbPFc9dau1gVEfyi
Cd4Q3emYk0rNf6BmIlmHLXLXq/SIkCI6af2g8E6dyftcNAAkLNycw3FSzkCwELKyW6tKk3LXUaZe
ElzsJrtJB2uYuBMs9wmbFkyGdhqe2j6DYCiYXYjyxYpnWCJuKoGBThqzMSuc6NXvcWBy2Hn6VRiP
GCCkbS2gCbvyPnv0s0hYrHK8mwq6to1w1Xxok4FsScNzZSsH7yyrC3DaAGpmwkui9nKsCLnclbjV
IVSQbPseEoRYMZgPTL0ZOqEU7zZ7AJ4qEYKchZiFjral9+ddMI6ITJHA2MSjuvMbPpXm27j49rtp
Fvva7+dlTaOWDnAUNvXVtp3KtNsXBc+FjXQtPJJVN2evqT+RtoSBak36DtX4PJq4fQ5qchC3rAcT
dCTs9U9K36/czeJNl4ttrGxvq7on0ikE07eRS98/5xNsn42/2tMbOWYHgW3dxVcd+Gee1mW0C+aY
8nRJUglgo0MTsvHRK/avsxWXVzGm+2G/YA0/HeB98UaOZeXuZ0963jGQI3Z52x8ktFTlnYvcqWKk
tW17R563E25RZgLkzKXPhttkY20zZCiq5dj0+fgJjVmVn66q95lVZOmIbWgt4WuLW8jfwvfhQReN
uISujCUHNHD5Ml0L0TXQCpKhfNMCD+l5HwVkfkEENBvXpu09Cr/F6ajJOHe37cK1ALPWtO92Vaff
sMXEj/jdlxer4dJvpeX7T4xrba6dTZ1UgudiuZHko7WzJ8yniMu8as3SjTK68zg1d6EcPfpgwO9X
Y5sioiNoa3j26Pdf8FnOZMTlaU7M2lQX1/WyWC/B4OHZNczB3kjoZSSe+EbdRcCG9KnD8Qe7OO/H
zznIrk98xhy1mZUs7C2ClrHel5bxiUSdEZRtjeNnDyEm9ppFFB/cTd/ZMjkMQVolZCXJdjjXbhsJ
yKvtZK5GNzMBw+bVTBqbcdBnPqmIzsZlUVFumdynqBakVVZbq2RDese2v0BErtvOJ+zNZUinDzHy
Y7NzXTGcIxVsiiuiM7Ng36ervp1tbzBfIkVL3GtRJfarlTOKW+kJcXhE7eTL7YIFF2S9r4257jxU
OSed09rFRQOhqd5Rs3s3Q8mY5VODYn7ZuqrOEH/PuFZuXWGl8gzkQGOfWV1myJ4cKo/k+CXzxQCD
bOxmJvxBVWfkMRGXpvZqHuz7AE9LvwMyhF6kdgNg8WkCJHidz9bDlWR21T8wCNblt6IsDNMiOFoT
WZFybLdhF4bzsUgGNDZiLt0vYVqFN4rPIqpFydfvKiPFK8lZ1mvFfY8iK25RmxcOgXCU2pW+A8mv
Fsw/XR0d8o6Eo4PlZr7ZrUPGK88upjNVx8tjllfxsGWBlmO9YX95jEPQwZt8DtncTFPTfk10snz1
VIGyoSvy57YzyPlTH08lN/RXgVhp2U6a1mjDoQNEYaLofQumabh3vKQBNALHUFOhUxwjho0RzLco
HhCt0pqQWl+44RcHX1hz7sP5x6m3ILLbd7pXKFO6hca848gZEHw6GwbDnDbsYJxll5PEKLZjhBuO
56WfX2RBNnyWPirZk0m13kMzTSWGZDPM9xKVFfohgqWSDX53jPmIqCAbZhq3x6EgqXcBuhPyBnb9
knRnIoOlxbo+LtKDGFlmEjLJ/ArtTjc82L5xoWPifMP0jPCSudESokQZJsJ2oSgpxDxBxL5FY4rB
qk3YJwmLUVxcLFHF78N57O8tL0Ho62aNfEY7DY+h4UBBDlUW5QgDP/Ke/cSr3oOEUOhtU/otCu3B
yZ/qpjEPnsy9gTmW7b/qsNV3EPBxt1auIUeqlCriKW60+hqwej8d8Ui+hdmMYrkbGg4Md5T1rvdU
tIbUeOWnuc7yxkBWtqPaPq+rNn4Y8ribtyphRrxZtBW9F001v5MLGr0Lt7U5nQCVUtSzz8YWo669
2iJDJJ6bS1UZ/ViHHT2dI3RzB+q0w5w552hfyYuRp1km2uAkhFkM/YOw2ItSE79Lv1A7SJ6JXSZT
C3XCSRwDxNyLRVYOArKZYAKdOvabPxlaSdOmLONnj6gzGAxJeYrMlDhNBz3KXegM7l3d5El0kHPe
oAqBNmpvsRNQc5k8vNNEu9GrRUWPhKaF1YmgrrIfQZMQ4GPXOAQTvweaVmMhAd3meMsVEU1kfalh
UKeZn8EnyQB6Xw1uUo5XVQUhZuflVXLPE8UuTkkkFg9B0KFtAk4aH1Llo2Mwlg00ZU5DmeyZHs/O
AddDae3ruvfv2arZ6sjkxH3sg7Q0O8dJizv4HO1N7k8rk9O28DkYdLUXHOrpy5qz9VaBdXujmp1f
yyFvnsMFFCNYm/XS4VWQ/JQBl3rLPY86SbQtFA/fj/VNFsTpPXbPMN4mA+XYZsJhxMrQKoq7KR/i
YhdhK3yah3w5r5PM6w6eQxLqWRvAPWD4DWHkFBUOGHN2P+KhqwhOZjyO1r5pS/PGnAezDq1gey7i
AfE8zmgxkjE9pM0mjbvgVIMhlThUc3FGXjup9Yh3/DNQHtUCWcUBCapSFSSopVTBQ1OOayI3i+xj
6IycjYukPFhsor+JbQCHskkaIx6pEWCkDA1F4i7sIvUl1WwoicwexmLTJj0mHKUjNDYMu638JIoV
mwrLjSUUjX6Jbud6Hd/AeZ/u3LwjCs+JsExbLKAYPCMB/lLDL/gWBnmZ7PDNUArVwhuibdGwlSxc
eHDAv0CiQMMI7sg2XfV+ZZxcZX1I9LtAnpkD1zFGwqQwfDWMmOhqCUSGmYPbrIYL8ujUZMqf5Jaz
COQ7U31msaAF3Q+86bTofPceFnvLAQsBHjO7p2LQhZKfYYJ+328IgEnkZnImp9hGQ4o25vf7379s
bn/ubf+DbZOrr++v++HNtzqrf26H13/+vRt2/oBSIlZ4NzQbltXrmvp7M2z/EQQ+ulwWpzgkXaZ8
fNE/WQjQMOmA4SRQW9o4KuW/mmF/JV6iAw556kMU+M10C+ff4qh4CTewqYVJ2SCW6NeIIDkX8RjS
IEwc+iY7jsQauDXHG2DjwzJL/6DMMMGlS5duDQ+a2Mfvx3hqvk3WgtO8mJT56lZiQtvAXAjJXds3
4CENbedGhWTHbktiAMrdRLouaqmF9IN9H4aFgAqMsx+UcCjutPH8q5Q8n3RfTMlSbnkud/K8N/1q
Mh6Gor4sJndxN7xwCxN44lsiuuLJslKOyMOGazk1542HI2jjDpwpp6yGZHqTo65E0KnzotqOiIft
bWCt2e4KDdgXiSEBTEhU+eGZmiZittteDTB7dM9MEBnzwYgWc6IR/PCbGCniuUnUCMxO+nmBfijL
3rsgy2+H3ANuxLfA0I18FhphwiMlRePndneccrTo6JXj+zhVWbvpPRMJgsw9F2WY6tVnGbmtRd+h
ZxiIrbIoH2BdvxDuCsm2I8zN2RubiAqq/AXebuYq8Y59miZ9xPfg7DzOyu6YWuRz7E2OEoG3YDDh
dVWPubsVANjaDa62fDioNuheo0LCmqwLJedNX8xYDeB5tQ+6c6rmaHB2tdvSXbXI3gL7oXYZhm+T
yEu9HXY+i2jfKazlNijneN5LBgTyKMlsRcRiuSI4MDoMnjm5pjWFffiGd0eW516fdxrXX4MP1xAY
N3AZiIk6BfUb6JMBZoI+OMvUQ0SLbZt489BFtZ4PKa4qMTDJOdbhEL/D7DbyiIGOY11Cw/6UjWn1
DP97YoeB0qumbbe7AM+VUQB0VB44rFyRZCXU+YEuDqDEAF0ReN0rVtVjdcPkgJRq9Eb5Ex92NUKJ
wJG+GXD2eWwXtQP+DLR6LhlzHc3idDcsklhfo4AnqCRHCoxlfmhXF1xIMQSLb/QvwtEDJmirEZlr
KQu2lXEIrnsTdfB7tspK0HY7A/Hh10kVM0p1gkNNYRbS1XbhV5uV872XT8PnYXSa6DCHRcJivCoG
ijhjwjcMRu6XfGqmBUVfEGc4TOb01RaDdQVtm5omGtYqlWeiWbMlRP1ISLnzSGw8S4OyIz710mqN
w/o1i98nqEnn7lgmb2S8y1vthfJFjw5zgwk6w6u2auc9K9v+SQ5jd4ZtwL2PY79+sh2kQyeArhJw
PX2azLiysGPse55lZzaSHKScnu+RL+DayRzuNOnhfC65H6ctsv/sKWiIij1IIB9gunuZtjtIp+wH
mnEczMaaKgq3wM5ZmsQq50tDhJUzrWk3kHsrMhDyXZS3oE1KuOlgfYNd7onyBlyjMwIlctgDtMJP
X5s0HB+dMNP3E0fL53SgUSZQpZfc0dD1v/kflxoZv7pKqknecHUByyqhT6uUEQOaa40E2Lg9zWPH
L8VaGy1NoBy011DurYjkusD7lsyOJm8R01y7SVuDUaYYM/FMLI8+1+Ai8ZwWrqLVCxPCqD0nCaJD
ITy0jVMwDHeZrauYrYNy4ouaSN6QdmQZo53Icx82LFYJ3jxyeOZrmKBOtRwMxwIJzMLNGbaMKsiy
mxpuztHKm+JaAfMeCPVVc3eYUtW/wtwJfNjtrXJ3VpMXPVbMpLqMBsv1L1TCN+/dFnDM5Nciv80A
Q4mDN6N3PfpNag2nToe1ZVM1GIX2+dyhKN8OZVMYJKD12O2054aHHltAQVi78O8rAf6JHysXfneP
Hrayd6x6mcihozCXtG1RemwzlmOgteZefGkxSs9fZ7aGT07Xr3TWktPtJHIxb0csZHriYioVbBsN
r25bpOVABLzPwLJQo4UYdUL5t6kt2TkkCI/6BS8YufGLR2oLf4mFAW1InWLagUB6n7HlfsaSGj/I
0o9v+Khzs8RSVO/Uu+kVj9wM0w1gGXEhUxBj/8eKpf+wtBS5DvP/ukb6/FI1f1oZfPz7HysD5vt/
8HCgSiLvi5LmJ2IUawSQUci+gIOzwg1Ynf8okizh/IFciWARZBChD4GB2urHysAS7h8oHgMSQAjt
woHieb+zMwAw9aeVQcAiA9sElVjEDyGp5f68Mkg6TPsVypM7WdMyb/q657EZxEv71mZxuk9xkuHw
xGTIzLctIYqKhf58zmQRnNaj3U2HjM+xta2CSPExnDCwKuaiN66XIpPHX0IgWFLAkNwhtm8+54v1
3KOGzYF7T82r7SBUJ+iCxd0+XhzrNgpCPv2xm1KMyJKAzv1ge+lb5behtx7c5Bogw8OyW8EivSHk
ujp0TIoZ3EgM8vs26zr2gpjOrjOTaLTuOh5PmTBwSCR10Ww6MLr/g67jz+s4rilrFepLgeSAdWAo
fkkk6rmy2dKV4q60qQmVHAilRHix++kzdfNdtfFz/suf1SPfX0WsIkHKZj5FDnXzz+qYEoHX0LWZ
uKtqV+1ZNfcH46jhYMk03TtjZR3+/vX+mw8Gv4rPL8YeCWFi8MsLDhKhj9N7851PJ3ee1M34ZBxG
8atuq/M3LbrskiSPHL9kgtP1tBbIneDWtZTUKKL2TqthIOVu7X6talt/i21qEU6xtVLQwYQyIpkb
97MLIQxZQuvO90MwezGjVmdu9tmqL6rniZnYUEX+sEX5UTS7ZREzrGBmYwgD2oA0Mbdy82slVNTt
XGd1BNpxfGURacGmxm3bc8nS6ZZwG/PMwgOQqQU54cXL/P4dwEkO+tnFj8xEk3Hr9+6Rvu+/56P9
2xXzPZ9lYMiQh0Qi3sU/XzEqNaEH45s7ndTvaNLPE4v3ZpHRiVXE2ffL9Vur2v/NVvU/7fS10fn8
3emb1fof55nW6h8v9ds/rr6NmfpTx7p+/Y/T2Jcfu1ia1l97Vou/QvUsBI1rCHOHw/lfx7EIOMKR
SSK34WKSLcWV/ucC9wMCxF9CjXCZuRLg/BsL3F+E7Z6HNQ9Bjy2lLTwR+L/mn+ZthmSWanGXWzq/
9Bu3uHVqx553VZDIm9wUJXTiJj2jGxRM1bxmVJucgc/HRAt7/2Rp8lXiSXxthjQ72IA2HmCrEMgC
lnu+Qh7DhmlC9lhtKq+yCOtuUZSO5pXNMlLSOu2KbWC7/Te4QMP/cIB96Pf+S4328cvRkQvW4Ks4
698U1RGT7KhmmrlDtpq9IBcT70b41gUzTDfDEewI4LW1OLXQWX1G+0MrGTlL9rjgdKQ3937YCH7r
lvn/Aozl8lH+6xuIsLdvv8SaiPUrftwywR+Oj8cc3uXHIMddC4QfmgdBacPqhWEN7k9UhisA8ifN
A1o4vgpfY4Aygq/6ccu4xKF4PFgE9Q3YLBH91i2DjvyXAsZHoc/3Y9DEvYmUc/37n9R3Ibsi0NbL
tlcI2w+gpSO1xffoW8COM9bRWtpMPuRUj8HGCtaSucsluwF86R7ywE77h9CZ+kOFDrli67bYIxDE
xKFPXGJl7wqUEkC9l8K+qJM0YEnSBMNtKiuGRnOt0uRAV7pYW8vJ+uMYY01jGJGxLCst3J27MRyh
28dJaH0zjPgjsPxJdd7QT/UkzizTmT0NxgYXQxfPH8CXpQUbYRahP4jOJ2rDL6WjrS+QjVJx4iJ/
vgvjsvrm101wGlo1uuzKsklnaHOU5gxa9xH60q1PyFm2m9s4/0zbUd9NGeOXDSlM0xOZ4xIwMeXd
xs+HFsdhHIzPSYZwAgn7XAzHOMMfso/nmtOiVVhUY5rCe8Nkwztvusk9DAxkmccufrZqwBj1MPqZ
WWpoW4WfA7XyVdLaQLmyKqe/nQvbeSFJuz1V2GXsMxTbzUthJBOXqiiti3qa2wEZUyS/GPyhNYAd
0meoMUUIWDdI3GAz5M54nnR9SEs2yOEpl8l0XnQ9ew1LpOGyduHtzUKFWjNQWGBYLMGQH/M2ANDS
KsHSxJtu40WH58kS6KdOrHVKPoZoYFSYZZKWWYegKLJlRUVjC7z0ikRcdVEW4MMlSXUF8Jb9te9g
pd+RyQRUphDFYyBr5mheqYPmbOSX+6zdytDBa9r0DcBT5iciLQWkaOZfJM4zVLyGPuX5gI+V+803
0Us9o07f4HXWWNF9zJ0bpor+9dRGVbajGVZ3JoyWN3j25lM8hO4ARNqLqnNCR3R7lBMbaD9MUAS2
PeYrt8rIKom9rP5Wq7l5Sy09xacjpLojopi02ml/zq8BsCfDvp9ln25V7hp5whrOIeumzFfteexf
OoSM1qcgUZCHkowEWHyevPlLlDECYpSfQeayRVV/mcOEdB/ZWVIfJJFw9wqMUw9/R7IU0IYghtYz
YE1bY81PYmmGZWsnBav+wu7bK0c22JKbiizXrY1F7RqIYwvti6A5taeDCJ9nW9kRKqKgmPaF5/nj
Jd27UyJvCJghDoWYkYN0Qxfu2GGV6YEddH1Ws4sdD2HONwYYFzF2pavOcVjiiSEOgUgAIK/5Eru4
u4MMHUyhimRjoyS9M45dvQs7l0QfBw7IIwQP1qNmkYKywzSYJTulA0xuA6lGB5T20WMjMfZu0nlF
VttiEnwOO3XbIBe87OsoeIqlHhlLRngctsQxWsMhjlvz3icdGMhqKReiiWVl3Sh4U8MmFgwRtZt4
CitvDakaE4Dwd3oRC9hMbVmk9TouCFupIbfAuQu3BDf7lyzQTbqLY6RpJ6TmWDRpaJ/Z77oAMtKJ
yLre9Zv2YE1LcxeRieHtZ1e16szpRf7uK1D9ZBbjtK26OJ6hGpnSvo1kkr6ERCFpXFmLp9hngcsH
tUUBVW7akbHjLVqEITvoJmyHG42Q5Qomlx98QomWkSNCLt/MttrMDNfBQxz04rKiLAIEFCy9iIMG
vK36x6pKelgkEwqjrqmn63nobDZJNeiDkHYOiH0UZq8MJPUTm3NyF+KBy89VayZy8QwjywGE5tdw
JFlvPxnIULeZlEW/g5W7PJTlaD9WecnhSqEfNZ87QdQbm+q6aPPradLODL6G9JdDOXUl+EAZVMNO
54FYDjiGYOoa1DrXPZEg2EadJmlpwZKwzj4R9wzqgwBnpLOLYldG+sSYw4j3Yrppo/r2slU1tIuE
m+xZNbxXO2o7ryEKxW4fmG8SX5J0JCoxZV4t/bh2QpgWzgh7YTMvvai20rMgJjEmQiEllAkIu0qm
wT00fQmtIsDJftrSVj31UWp/iss5Y6lN3rTYMZTvuVnjUN7N+eiTLMO5dTnP5Gvc1EtIVG/UjMUx
MQnzZeCKPPNs1tvJAWaQufWNMQoX6SjNepxPBDhTPoMaCbSO7VM7MKCVt4Oq22sPVO90SMvaxWMf
FurG4kIC+hk50uY2z+Ndis1vOFokMZx8FCu/VcX9v9n4rDjkvy7bMPGq6VetKl/xvWyThPFSdpE6
z8zvgzn+z6qNwF2GUetoibmTJEWWgdC/xk4Bm7tQwkLFs0F59lOjY0n/D1y3NnoY6WL5CpmJ/Uan
I5wPF+tP7QDTMBaEVI6e46Mm+Bhx/Vy34bRN7F5X7cbrmUnueqdXxauVFlRYbol/auv6hCfsgpj8
vGuyMRofbJGnwuGGUgcUIDltM6YukbBOT3gT7MussoZiE8GdjA+jgytmn1ayHC6SISmiM1tTVWxC
8Fz6PjAo5E+dpU++ZIMw6sRfZh1fRuwMXuyJ9gjneyqYC1tj+MLEHR1aGg2gUEL3JSCPcV8gxHzM
gsY7+BOLvK5Iiyesq1698+LqNYqmjEFrFu7CANmERXbNY8xcexPAU6VYiJwvFpOsZ+qceu+SxnnT
lyjLsK/rPUq6indgZrji9Hl6Q2pYDK2CS5qRtomwiqsG6MoOZmzgTLnvpGm7675CDLAruyb5tELT
zisQGkcMRgbs3hp0hGGMwdmggr1IR+cKM4MakVwZ/42srSdOeUHfV0OOm3pBihlYUcIX4ubQuAto
zTgnRhN8jjkuuqhGbPixOLNxLhJl6jfhNSdT9oruV0BcLe+8tk5P69QkdxFyxBIzWZicOP4U7uc5
C++z0ebr+krley+M3/uwfar6okBXycaJSzucKaww22k2aJbSiIQSX5CbkbTFve9MPL6aXdq4k1qJ
0uLQkP+5S/3aO2BF6M51m1VHLpi1Wxyl7gvdies0FpdZU9xnjodUmcyGiK1Hljwscx+fV4l2iZ5H
C/rWj2m2s/pyOYGOZIirU2V6CVbJDBuJlH8b5DzyUn42DAQoHYmUGs0Z+CqO+RK+6IaYnfR0iHsk
ca60PkfkQm9Bf7k7VhkYMWu/OUZpuhy6dOi2w2x70Kkg0+c8sw5OIffEGUe8nrryE7NsBgeBoykA
9AUt6hOHBXQ4OpcoN6ydX0TzBUO4K7IznHP4P+MGjoO1TVUvj7pcU1TlBBMvD6qruNH5G1mBqJhn
NVSnpSbjzTjoNBmydg+IP+3bpe7abReF6VeoX/jMFyc/QmJZmTx2ftX5kKhmi6U1bxsj11Cdqgpl
d2ot3RnRSBkeiupiKar2pE4Ea7FwyJGAs3ZHfVok266QLRehAngVSp+BhTcPe6S4NfdUqu5oO8Ut
yzN5zPOkO8LjuJdZhDCFg4MGpcF/UYb1GQJEcQ7wjimFFM+TQx6ZrpzkFhQxG/rELb1t0/oFOUGt
uQ5rw1AUisnOtkZvW0b2cVns6lpbXn0Yu9y5JG4nukbGvlzVVpege/bUOYpJZs9tFblvTYLgjdJz
OlWdwYOfpcEBPsmj6Jm7IAoM4YDN9WUuwN8Hjv+QILw35wk5gcl2Ip0kPFCkiLPEpitkOzq3p3OC
SIvUFQ6otA/oMxPzqBfcxEsGuWjuuORpFpfPoZHlNs75Mk31w2fHEMmMIF5sGObs8GldhykznoyU
FWQ8EsRuUhNqbfV9fhoD2yHXOim/TP7gnHWTgDdjoDDBxnPOGhHvYTK8ybF4XTVpN908pIfKImKF
9Gx0Aapu1IOp8mU+Evq19BEUmepk1ZcniNEKaxpelYA4tt5gnm7gaELs3NBpQBhViSdOQCrUQGfY
JZbaBQiVu/4lQvySeVZpo29Ns07cBioKwGHxrvXYjddl1EI8BB26o1y1SSou3ScM/gZyy8c6eRLN
rh7Lg9MMl2ZMT1Rjkz7ct6dlWVzDfCtp3Yb8RCazOIrK2QEMemiT8awTEvVXX1zY2biP4uDVdduz
3CUlKnAPubYlpLX5xC5JwoKfuh2b8rMmXXhjWMQ1ZHvbkLv426MS9qGaYv67QfANTyuYv7rZZxum
FCFOTx3KJZPYh//F3pk0yYls2/q/3DnH6JvBnUQQEUSTfaNMTTClUqIHBwen+fXvQ/XsPSmPrmRn
fidlZVUmEUSA+/a91/qW0akDluMr3+xIOidXtax2VoXKkRAFsrDRKpZnVVnneGoO6ykiXiARp+1x
ZtSbwgnxKWc9XN5CBbsqsfYoVW9ma97VnGUD9CXDrEzUWySD9lThAgbKdjX8cSRv0bQgpyy0+N7K
J5YDMyrYeoY6voxlg7RhvoXRt5mQWT+ypNFW0wwVb9i3wNnij0+3Xk1G69Yb3PnOqkZEp4PAcI3A
q2XighSjvmkt64I2+6GoQIOWUOS0vAuZfpqRo5f2dVkyo8GtvSynrBiNO6Nje021QpJ2GrtPrZl0
wY7j8pPneWlUdnjpUDAYVPWATbYI2Zc9kM9q7wQIBAFZwfiBwblz+uC7yVHwoKpA3y61cant5Ktw
WURcRAIblYJQwas3HINpfIunvL+KUwxw09BZyMfS+Mad0Dq3ntVBLW5OnKPRwqdkX+PhcfZBbp9Y
CFME+i2uYyHHkDNpaDQQIkVw03gd7Lp+wBUOIBCOLCGftEra3eiv726v3mnqXxnZdPT8YnhbauKh
muCmshYziseAMzAZfY4eP1C+yy3lypc+hxhQdYqzVOkiWXOB3FaCuplhdq5dG5O+XJWeN29zBOmK
nTBwams71Swf5ZR8ypUiKkh5p2GWpySWd3piXdrRZFlUZeQPVrzxO736NFZNFlI3jHAk0Rfhcfe+
jMwST2XQ1oe4j+nXcLxD19KWP1CixiveSLZylm1pZTQGvIqU9koJ/7s0hHlxq6raOW1WvAAN0l5H
b7li7wBOOviwieMmsL9lfCS31k2cmEO9Y9WDaedwgsE0+zlWpr9L9MHYOaMOmHDwypr4Ff/VmBIH
WXH8MJYBopic9Y6eOLRvaOAibDoJKdBuqlvXpIOHCWifW2xFmVg+xUE1crYsbwqIskI52ud+kax6
Fk21zrqoccnBt3VHNWqvZJXufVjaKBTkPiWGfZtL685ZCFmvcutSYcffADLXUBgsrBSm9l2K0b5K
lvF+0Yt7CAKIjITB8yvOfemiSm7CKQ2K73jtUUUvmhvGULzw4CyHnAz5CK+nF6YUpih3mFZZXQ8+
otXnJ4lOCCYbpZegcbDpDevVZzrvxLm5b2GCRaD0z7h/0DdW7Sc3x9KTrM7lLsc6M8RVt8fqZ6H+
t/WWe0rXw2U8laelnAw6lOOjaVI04Un5Evuk7mStXI6FIkjTY0CqKeM+lf5NnjtAJuPWmC9kUclb
6XndvuhTY0cNTCsk1txDgeTnPcHCUm4NPZ2fDL0Pxq1LSuQXAK0IL/0SO1WWVJLMU22+NNOEj4Bv
bBMA50Z7POnPCGAC5E6jFeZQMI6zxrkdxXi7aJFREL/JVJns+liS094PjUeALr+pjoxHzfqpdNH0
tvhyOQOnOIU5qTfWHQLl8rMNsvzSmIt/EyP3uEKhgQZtnOJrzB3LLXjIxYqqul1GpHZufSVns/1M
kjIKIarcY+HpA7vRpI7tGqKD2Mqh46L5F0BocC5MAm6uPK0gGs0X7Z5S2ztNXv6SVyDmmHYuxkEq
2zhLI4EgS34khVfpoqpHMzxl9Kz8NLtdUpQ/zjS9ERzwIzd6qm+TvtcFZCGogc/GhCzxwHjUY9HW
3PG0dJ2cDqCtmutuHubzYBgaHUJjmgFPbWVTe/KQ42Ay3idnkZEWrGITo2dmE9I5u4/trBqjIMMi
TLzh1D3Ro+GFcfra+KKCNn0urXhRWE0m5wKEQINGAhdgPDBUSrp3ixw/dzMSoVuGswFrfoe3KbdO
4O8z96ppmro+s1Z32oFlPNNCDb8Wjris4UQx+zY08kXBHsk2OtDm/kC6QK7vTU+2cKgytw0+Ebfm
E4HI1B725dRN2v0k805EjAZspJRTbWZkx3Wu2+4QIRK6ChRTmC/FJPAZCxdW57bDRuyEQ1rLz9Mk
8FB4VQXntVCErx09th3zVtlLz+K6zCTHcXziRIaokP72bkFiIXhhkxTFNx3EN5zC1WNrap06ui4r
zQOwi9i85mjJNu2hBR0vNe0n0ge9uSD/RZed+lIPTU1gcDzY2V1aBZU4WanmNMels/wuAkdioPlX
2XQivgoz0BhTYFtdxX0hHNhgHWbkZuErCbta4+iSN9m3GdTj0eqN4q1M6yCE3ajuYq13jrCy3Vvc
L/qWbmm25/fRtrmHySJWboqCrCE93Z+09HbCA/aYJX5YemimbePoO9oSFgDkNrm2ji487QnJ/Y1V
qb1ZGO4xtqQXtcQoWgR137BtCCZunF+rtHvJS6A27tCCq654eopg2HvSaO9J/uxh2zTBdUGw6UvT
gBKR0o9sVz3D+2rh0mCBGYhiuDXjNn3Ao/FQVnxOzPVPCxJ4WHL9FvT0KaiSYJsP422f2eEoSCm3
Su1sFFhBUYA/SpOgbuD/9LjK59EVsDxh9+yWoDW2emPfzY312lXBiXNBvAVLpiNkbQ5m0X/rG3dH
0O3zOAbX45x/iofZtmFAMv2B6PbMT/3K9OQ2bRwOeFr7pWxuacQdnbr/mutNBM3ysiwViPRcvro5
P8AUbKt+Ce3UQ1s70pwX7TFv0f8DVH82a/2+lfo+VcbNgPsJ3ll9ioPxG4ZVdBFJ0FybmnywS3KA
S726TezxvlhgWbdQTZB1EQsu1NUUy3PsmQBdtAQ4af89MGmFtMWpiKf5gh2CKlRRvjfTLoMvsEla
dbc05Qtass+cx8fIKuKjC2uTmQFnIl5DdBqHdROss6hqv+fAyzE/3JY+W5ll7ZCP7Fl81XbUgV32
yzkFkIfSUIXxIu29FudwGIowKf23fl77l/MRVcjrHKSbWo3Z65zKaUuw5XFe4tfSz7/aeATOhl5/
puNxnEkjx8Lah9WcwGVtqucpMfXdYJMEgClXiwmQ1xYgyZ2bkeGtw3OerQbE6MgX1l97wgbmrczl
S2/zOGZ1zufGnjnWg30cJhJtW93dDi5c8EbykU3+JlPWr/ih15C0db7tl+8dVN+mx4tvsaCvNMUz
LeyL72lhLow1h1n4hL8bik6/dT96+VNdOHcyJ/3XcToUt8wxIKzfLb579ILsiB4AJA+TJP57IWzv
4Pflg9Bk1GNJQ3tySHLzAcvntT4l16TEPE/tGD+VQ7VDGx565nJtBcWTpatQ9P4pVfqxEdohW7rI
W8jQxgmIIWzYTF6JbkrWB90cz6qPoy6eT/6AvkUWT6Wpb11/zYxPjnVQP5i+kDRpypOBotjAZngJ
dFB0wjiQr3u0pEZM7VAzY8y+TTah7UW7WAfd7k8M83ag+u6tOZZROvOCs8+3Gy/FjmoUDgkN7bac
u1t/0fwb5bY3dE6ONGlecpm9xxSGC1t06PdFjA3KHi76qBjPVzSd09k6g4itIwA0YZeyYuSK3nOe
zmOYd1pwi++MtnuOS1no0t1xjnqeJvIdbJTemwxPdgivqborU7wcPh6arGP77WjGMyIqb8pKf3BX
QkOOD9mVV34WPzqFs18w6NwPK0qshqm/mQUUcaOlswGUA3SuR1/ntAj7ZGCrcVSxw3mrRbR09E1T
mrBRnAdsd8cZHzl7W0KeRXteWt/ek+BTHWh03MXWcKKdxbmbnmS0AL6YYm1HiF7k1FV9aHVvz+wt
JirbeVvs9EUCrfMKuGCzz4uSebDBi/rayq1tpwdHNFJk3cA3xd19Iuh6h76BokYccz/YJX4Z2aTz
XGnddde0lwoU5maNxy56xlJoU8IiCHBUxu81cnBdkKYGF4lqog9zZNbPXSLCoE0+yWYNVJYHyZYN
C2tLvtMt6zVRwlhonDz0eur4yrO0K9Mp7uM42Je1u5v7e9Cnx671oWYuoVqqe2S9OzsgntzktFZT
o0MsHs1i76Lo3eikkpK0awXMUhzCsdUy7jmC4y4o2i9+uuySOXnsRo7iWZm7e4Po6Y2jFVgT9DZS
jfmtrrSIadZ3iMbbEpLZBu92yTsdrxdohk0/qUecXFcJY9NaojWzSvc+FaSi+it4pXboAuoMpDKv
fVdtfUL+/JmQp6tyZLxkTKFbLp86Ub4aQbF1YkGxIojJ0OtmO2jjrU8YQe3057lur0ZqDg/hF9nI
RJyDZiqM7FNODLsyOtDu8ly32P5yzbtyKtYOJ6aJQWQ9kYsxQ9fZeZ07+6Zwuut6NqeNgeuFFb/s
tx2GMQqJZ9H4ex22Jy6tVzpox8mtDqh1IMLGiXWM4/GiB0incf1SXGocCafBfEriJuwrBsc+fw1g
l+kqXwZvw7TpwderVx+qb5hN+l7iStkQoVltC8s59U5t7A0zsQ55W32BxQv7BXXQMA2DfzTSnGaq
Yb/aEwVlK5JxTyI6GsyMo+CM2uAkKpuvJa3TLQ29t4GfgKCg0TuMroyoB18LuRK40m7nlm0cUpIK
tNnBHTO1J2yuwfgScIyilM2IqSXYkMQF3Cv8rRBi3HCSa466H/lVopX6QyXTqjTgDxH+M2hbL+ss
azuotC72i1+ZIjRF0S37UTPie4kV0tpnfpM1ZztfivRQxjn0igr/Eb+H63g7e3RRRQosmlsF2jnl
CNeI145avdxjh4BCXfBkvDeAItS+KHrnO4oy775Z1Hjf6iRU0IfUSC+ZqJ6wzPmCNSJBVEJPE+qu
3LlJJ15HKzGKrehm3JMMBWp2umosrpd81O7b0REvTEexy3Zl07Zbc07nF/x2amXxQV7fFwm9+G0O
HSbdZrafPZkTVBtIRcglMc2OHmEeU73EUdG2/IzBlAPp2wjb6dpDjY5W4rFsXIAek24RqVTIgRZ+
7WuHaW6qzyb8nbvR75YbYyqSlKhHat5/cJj/O2b7r3UA9ocx25eamc/7N5n+oinkz/wzaAvMf7m0
KkkoBbtiInZCOfWPPMr3/6WbPmY2hmneCqtFNfh/B23M0kgKhvO6gsos0zXQLEmQtel//5ep/8vx
0CeiZ8O4pvvmfzJl+1WBihxxNedxZdszXD7IR6JelZgzmV5BFi15Y2N3m5kmpJaH950kchRO9j8i
1P9R8fqrFAvpFWovHcMf1JAVnhrwXfw80qsJDiAxpE6iOWYPtA0ZP9pITigZVX41+6l+Ieb3bxy0
D4S5HxflpAtEdp13ogH79aKm9NF6NHZCs8vRLrIs0pCwO2sd3xR/uT/GqT/hdX7c3zowXfX4usWP
jqjtl/tTqJ6Ea2bRPFT5JVhsRk/wbTeEQ9AWJd2ZRgBH9R//xhl8fPrpyfuNBPzD5X1u0sfPCC0I
CBGYuw+CYlBey0iEURcVPdvwWFYWqotFuzVTTEnIJiCI+X1qX+eZ377VzGkOf76+8eGr5gOYFsJU
hK4YPPnnB6U75z8nHlyjjeJh/ZGRcD0NIIo/YwiqQta51TIGrf0szJaDRDsc2oqdlqXNdGER9NJ4
8NxhOvjGML6QKYyv+M8f8MPz/uPzmWhnma85lonA8NffJ2vgzfQlVUbrp4B7cQmG0pncyC/VtEOF
rf1F+W+sPKX/P8P21gv6DnJ83BM+Vg7nwwOvdb3fq36gJbNwWSq1wTQo3OAz7fS4se/Tps3vyUQI
C4Z0u8oncAHxujdfpoaNaPfnuzc/vH74EGA3/1hwoN7izP3waarBA2mLmz1SpgQeBEI8aDbKM+Wp
NQ2MkQBC84sSQfOSDeLdZRc8yNFddrKk4UN/0U/vLUiAn+3GJGvCmrpkbZtn9nPSD+LYzWS3cBL2
sLZPvUEw18iGeYG4kF3ot2m4yvwRJX9SmvtYNfGVZ1T65z/f4g8B9M9f+HqLgYminsMX7+HHN1D0
vdFkdVZFjhh9Wi7oo6yw78X0VHaUT5xRpueGFEedECkjuNZLQR5FWSWXbrDloYid/thUsXxThqPd
Lv1UPpTOoH+e0ENFs8rLh5wu7ytiaTLxgK6+WwbVHOhg88uwaAwlp7pHmdCaynq2pdQ7ZmaLvALN
qnYtw7+HP9/u+kL/293+YKG6FiCrH7ivn6StJFPGBeqnMloG5svuYBdbOTva9s9X+fjW8J1Ck4NN
hnwW49mKJ/t5VfMdcFQTnysi2yl50VKeHBJfj6pbnG9+oU+bP1/u4yLy43LMdNeFzEIv9IFR5k2y
TZeOy2HKTa6KJjvxwaZtYFFy/vlKv3kf2BjWHZZHBgb0+kl++vrgxSDjlbKMRpUkVyX+zafc1cuH
BTLgabCy8qEy0uz+zxf9uEivt4cGAIGsEbAEmR++TeztASeAuop6u0/eyEzAVe4V+A6Zezco3L3U
tZ7nNbeh6FG5IpxF0/Hnj/C7bxg/AnUJDjGXneLX+9ZG18uVXoiIAa0WZg7woK0csHehJKvivyQF
//Zi2BZs0PE8RB83pVUG7ZoYz6M5S6DxaGy6nJrrc5DYf6PT/+73dH13rYrI5YY58Ot9kbrTypbz
ATt9FxMNJ42rQU7jCXukf7Ktoj6nlnL/0Zf9jzXN735PIp5x7wHw4zY/XBTzcwngyxVR1upMvu04
u08ROLZb+jYwJJeZ3zAbzYlmeJf2kiAsdp0//56/u2867JC2ASMb3keG+SJ9hui+Q8c81d0oMV33
CDhV3zWZvONEReRyaZZ/29t+97sGWA9ZadFCeasd5ueXx0dehjSIhyjJ7eCaNBB2Ns9sMR+jbc//
UlitX+KHhQ4fACBEttFVl/bhiRVUin4x+k3UsmddQ75+UvKvu/VvLmKuBSqARJ4gEit+vaMqsDqG
fimPTzLhTDMEeXcMoWTxny9w5uoHAoO6uhs+fnOlXLDuaqOIwIfZzyhkJe1CATNdFVYt/vJsrCXn
h2/OZE2htsRjSmn24aa6ZiwUw7cuolIxD1UarEGQKLkQf/nVOdVa7TYeGoUZW3Mxsf6/g9DtPxf5
2ZH4u+8TwyPmC27W+7cwAS1nKeynukM67mphp2x85OO0+/NFfrM5sVHgRESwaCLP/vBkKIKIeppg
XSQ0r8QsyAX6jL5Ew2GGnIS+//rn632khqxFlMUpDoelzxLOCe7Xp6Rx9ByXeNVEeguUYmsrz+l3
qYcac2P3DT3pRSuWW7qKeOK1PE4IrPOzC0J6KBYIyPz8SN5YcFXHmXwb3G54Y8GCqJ6OMc7JDLtT
bPfi9c8f+jfvKpkd0DThqugIK9cF5KeNbhltNFa1VmMAqe29B3jsah6lG9VOrF3+fKnfLIdIOfEd
czGLk+rHr4ccunKZBSl3pATXmGby/ILiYRV3t/Ju6I35aFp9T8+VkLnLSMfnP99vyCUBHMLRloNQ
YP16rwPq81Hz+jqqIFqu9l7tQsprcDNkTKj+fK+/ebfQpto2lGrL8/7tZMn5mMZzulSRTcl4msi9
PkmXbPcNEngLyRdyb9IuF0Q47V+3nd+s+ZYLZMvxILn++x4eaCvtQ/eqqNUclt+FomFJJmQf/Zjt
ZdGOIMaD5G/Fy2/eNvY4sHu80eznHw9QtKemdC5jRF99bT/XxawxEJhaEGPgA3O3+tvOtvZaPi5f
FidZ4Dw/zOcfX2+cgEYFrbCJcjRlbjQhdiUWM9PS72wC3hMbIvENA3raJ4Y38S3+QfgTaQZKAzZq
3n4XtlE+jLnJKaBD5nLQRG/54Tymb46dUfsXTj9aW95b4IowsixEga2KmtaUj6ws4tOfH5jfvIe2
zmoFSsRwcMV9eDksV5e9XTNRNIWmoY0tXSv0EFR86nND3fzH11oLAp7M1XrH2fPX98BjEuTPIFii
0dWSsDfGZb90mjwEay/iP78U4cTsy4QWULl/eOVmve3pb5OJ/qPjIRH+b/XY10IbsmH050utna8P
D4TN0Y42A5WOCy3ww1dI/rA26sRvRQieOFH3SH7pF7jiABRE/1z35gIfs3Oa5YYBEUXXMPtomNOi
fJAIFYst407zdvbVcuk95s/2Mhlqx0+SbVN8NG9//rTmWgT9uvva7L1U2piD2ezdDz8CAkLpzIy8
IpijyVmMlvhSejjasHqluHGzLHkb9LR77B3yYBguxBphKeZyl3hpe5Mv0NVTpDV3HdNoAAqcRZpy
UMiZe8RUmfJp6tboQrJxCLvYrc7jCj/58y38oBP8egscMKlsWVE5Wv/bemoQa05V79eRYzJ0Kocm
EEzhibx0wBlcKpafa61O6WD0pNroiUG0b74c//Ih+NJ++SZpWrChmCvMguO9w0+/7js/bWF+DY0o
S4wm8vrOR6HVtUl6M5LnQKRgjjYo14Ybj9UJOuP47OUFYh2nyxDTT2n23SwYKXYNbn7acf3DAIuX
lyHvw4TxeeTPyCodPXXPiFVuFCIzbYFlg2L1oI3O24jOOk7VmeYN81h136YJlrz0yfXWx8uajkkV
HLIgB1KlgdRz47reWsUZlg7yWIhdwcCkRESMHnZ2Wt8Io7sQhnyQYn5Cyr9VwWe41AR9MEcp8rt5
VKSQBsuxWcoQW9ZrJ9pQBWg9aWLkoVu7Rz/3EAbpRDIlM/qS9tnHtiRGdysc/yLNDGRVd+wzfQv9
cdf37X7lQSpZfRuYT+pVdyDY5Vg76c7x1KvVy62fsR3TvEjLhv5NAStZY/jCgIFw5Aiv2nlyKgL8
ZLID5bVhvl6Het5bW2k7nwejoR+wBI+oZoizvbUSnHvUM0jOik2TyusMn1JUL9pldtJ7m+hOIrbr
1zoHADnkrL/xm+W1d/Nsb+l3v9DSCIWp7z3nUvTxe4apbimSx3ZWx9Q2r4W37I32JknMs/K714mR
n3QHWlOoBruxQKEX7OYq2zLfh8cT74ZlPncaE+QFTSVY75OoxSFr70dxlrrzotx30GpqY3qopmt0
6vM7GUZyg8tfbl1hnlyhf/OH74tpnQaGaSyoYZ8mh7JzNovvHDF77dxanjOiuNAr+M/CgLcf0OKF
6HVllo1H9VecDFTN5dBHXpkR8dMkj2br7nmKNxoKW0uHuqqT9I3oAMJYwWyakIGbcnCfVjoRWctP
QwcDthIot4tjhRRWusZX0OJ7h0FTaKBs8/DhLtJ9EoV8N9NuQjzLtB793MHD+Ga5+W4i/lAj6CkA
w7zpZv2zUzXX1oxeNI61gy2uwTWPCU1aqE4B5G6COJDCIYm0nMsircNSs83W7jnpcX6i0wPMTpqj
kZ/arjQ3Fgc+FTx5PQqq3CbxnFxrkmuugkY2YVGgUK8sSHUZkiere7WL5iuziCsYzedayBDnHBJb
oh/B1V45DUGt4Kh2k4E4mmXyKV/aB32s7oxAfl2Y4C+cNbZ9/K3j5RKdsTN63u2vmVGcbacIBUEk
uf5SM9oteE2yfDrMmXoOZI0sTr5hgCY8GR541abfJU4F8uE3ePTeU+hlJvBUwLdhOmWhrrqdppRN
uLx/Hubhkg4qStz42BQdWCpZdmcF5w7r9ZXtmk9B7YVT4zyWjrI2+Hy4WVaQoOXvwLdQ4tXR1H3N
rgjVnZRBMR6B64boA9awnyOT7Ugf0vuFL1C0xblkHRn8LGCe3Y6hQuz6as1pXx3KJrWqrZxoO3Ja
FEO7B3J8VabOqwnqBC/RjhR7BC/iPrOLliSn3A9b2HoIxnfSFTDLZbPq4ak9mFMg8i2QELjosTwY
2u3cXFedeEN9Uz77TPg5UuxbPfji1eoClQpRU3NHN9P1enA+yh6jnKgLPp53qEF8F3WPLm6ptknP
EqQNyU0NubDdFPZ7pRmPEFeunZQPLJJocSJ0ZEhWIe7gioQJh64+E+mdXrwbEHl9oV5koEVymO7m
vt+Lynsh+ncbk3YM+fBrs1AAICeNQ8Mjfda0UueTs3jGcTbtWBz85iw6tL/oGet90PYeKmqJUdaq
HBwOpDY/JqqDIgov1bxBIchnnplAgwhYaN8e2rFv3hyspxo5Nm4W9l5ACsFsJ5thyT2UXIX3ZNh4
lLyB28OuGuxINiDW25C7qTUQs8UaZoGsTLR3X8QWVUpeqm+eXO4JIP+uGw0BCbO37FKGyjCVgmEr
XLQtArbAF33qtKODchhDReNdl5jgiR5X4tFZundcCtmVJQI9orcsodIwiHriFUVhSiiuezQDSYoM
pPbhUBqLf4xZZm8SlNiRqc04raCiao8k4WRABFsT/aWeuQSkTdp3x5Ri5weQATc6Bon+AgoseMxa
SH01wcyULiSXQ5/uIEiKXjj7Xkhn2WlLbocwAsBBwwjorxrsAxmN6Fh9CVqr0PdKOUD6xYizdXLe
oOuTGN071fzaTXZ2lEDxSDeljXQYkE6UKBpcB0eDzO85wZU9/Xn1ShldfTWmfjoybrEuZVWK5yBR
w2bGYHblEkmVbAqzEPxGY/qlsuMH6fHCV2U18nItgb03bb9ZFY/GdCPHytvkUxl0yDGXQW3sQAZW
WGZls0/11RowZ0VoLiZ5NY3e3GptLS94ZbtPmVvMyP/j7OT3cXPUABTv68r2r2YiGW0WxN5/dW2t
Oy5yXXs0lPzpqF48PEcorrX0lFvOe94pZx/3IAgrF/MRB4UHe2q+YJitoppDwUOviu7RwfsQyYWG
wWA2QMSbroKqTLosGnJsMjv8b2xnXWu+cXyWd6lVkMih7OLEVMc8Jq2bPxmaoaHXNruLDqTLrfLH
JVZ5OGRjf2J019UQ90gNqnMo2a6xjDvClNwdjMgl3eLtJXIud1ER77shn/exgcamQFtDjkTKZHOT
9GoYdr2Os5DdruQ07896v4ouZYl0XDtgQ/ffJgwBHLsB5LloFLbFFDs41lMD9L9fgc0ok8uwtHqI
5UNdgYC3erxOpQoTNzCOK8jJ28zoL84Wbjns/PawMZTjf1ZjTt1e+0NYC/jTW55x41hRBGoIWizt
2Z/Tq36JkfhMszhMU2Z8y8gn+R4nTvIEaLx5W1p0tB6iwZ4i+mCA59jHAkoUCh9x8chF0Fkw+szb
0vQFs+oiWC+8EUfpWLG4ZKO49gJDfwOnMEV1mkwwmzX9XtplQjmkmTtVjisZYVpOtnI9APgOJ6JR
GNSOvTK/uUOlb6lXkcnoE6mStflJ6hYDU23No990U78gnUr1+Vx49kjaVSL4uppGQKsWrfcUj9rw
ycZhekpq11E7WMhENdJBVNHUm/NXnxwMib2Ug20x4lLaeUK57AE5O08LrfFmhklVbRzo6HdgkpdP
Q2YaiNYmM5y8Qa3UtFqjtG0n7c3I5+xQkhy8y2HWP5Oq4J8nvcCU3/GshbZaJhJK4m5NGB8tuVVo
vw8p/PRdTJEd2ZxrTw5Kl0cNimq3QUhpOTzEprjFuZKCfkUkO2yKKrb3iU5U845MbQ8h1diShsHR
OLhMiKn35KZTRSfCwjwK/n3D71wc+fHMdt8MQh0IrqjeXfq1D4r23Zusv08w90cW5/IbYypr52Xe
Gd025HdFSJaNrNNaFT0eRMp0QbJTlrqH6b8Kzn1PBIqXuHXBp1As5qnVxl9cxEw3vcgRkzXQQHth
w6olqmB4cccKrX1FXqijUnCvSRlVU64jsrGKvdWxUc8Bwh+jRarDa4tomsSMHX5Q7tWB7T6VStsb
lWsf27lfdxCOk59HBCXFFtOj+4AvPiheIAlTLHtmHxn2CKZ+GNBBt/38zYFge6URDX2cy1m8OpxK
Dgy38ztTON1B+p54KE1nRNWnpe+zXS/PYszLHTKiQ2+a5d3g2c+yS6k+tXEMl3GtD0lMn1m9mpgq
eCBwi0RTJgyvdmnbV4PvJKfKGtztkhSj2ExomY7ObOkIdRnnARBfQJ8Iu8seUUEaAAMlyV5rtXDT
zrhkyT8j52jHH3CIg5vUKp8sk7vFJmbI6gZ3V2kNOxuG8JyP5GSP5ujpe9Rw02PXaP4hBmq68x30
BJ4prjVb4cL2RMLQs856/2HxgKuGzLdIpSEiwH9Mvam6I+9atFthaml2GHuDRoX0rG+pDsnALi2E
8PXcZnfY0NMQZXoL1zVtEiqNQBx/UOX49suLrWvRzOT5zaL1eJwqxOCb0nbUwV3NXGGquvKC10y+
Q3QnvmMR5BmsYROCcfhIpy4kocXcTdRB2yop6++lNhjXwk2dJxXUzkp/V8lFlZlVUgrh8fSDRq2I
fVe4O4L8hjuVCDNa/KY5mlVCiGGTmWfU3qSWoOK5FjP01yAflnNXcZuabOiUTQJRGMcFOLy29QXp
mr8lbAfmgiaxJ/qWjh/Whck7t051r1PI7sAyCqQ5ol3OLFjfUisAJ0q1cpZ10kYN0t0vakp44D2y
jxpNHSGfBFh6W3WBEFRw5rTKG0quZEfPft76U5OHwrbecjV2n3QA0BvEigZBL74WYXB5NoSBF7Jo
kfYWpd5vUt2zjtlE3A7KtWJb10GO+b5Jd4ka+zCuHS3KiGoLDaO2LjElgkkiB2ludBEpPOE6K4d9
n4C3eDuz7D+gqKgOedKlVwso7IT/rep96ynrpihS694qxuVaEzOtizHoaUp7wX0nYvnQIc3AlbD6
pZpKR02jzz72iaT5lALrDvuxi5+JWJN3+M3zDsgRbKlq/YqkV8z0SvIh9IAIRl43AmIrcKvErOI1
FqNH2ygWOkAzB1cGpjQRjKTOrhLpHgm3Sk66XFDJmpCNJDZhUxZ6ZKwe/RjySIqPV+/uKXC+u1rV
kNRVcw5Ju09DPHWvXhe80VZQ29ljDTRYf8cCR0PVGZ/xBTe3FusCWJJquf8/7J3ZjuTImaVfZaB7
ClyNJDAaYJzu9N1jX2+IiMxI7juNRvLp5/MsoacqW6hq9XUDUkGFTIV7uJNGs/Of8x03H541FUVh
ZmrkVSR9u6smi+dt3NIHUJrVEhjwUtayw5AiTTTWzh/Ksy56f2OLod1EdBEdPT92wqQu/DCOVEBg
v9vbHPKoyZNbMCsmcFlrNsKyXeKXztPiPRWF97ZVPhYzMe2xHxoqDrQ5mOyoOvlWibPXGAcSZvan
TPPr3m4SmDX5B5vNDT0c6VtaCXHghEtovhPRLvMWgpdL4m20jLbvqVPICqLEC51OPQnV6rrR7M5z
Jqlx7IZnXwe0gxtWHuBBAFLWjcgLYCrTUWYIGhVDN4qgjGviKZtL4hl0BF55R0Zjc7vhcYYn428q
qYlzVgxJAK5oJHuqadslpVfKoWrynHlTeTNlTvMNOo/YutX0IOlMDimOJBIi0/JFqnjcqsmeyEGo
x9afTOb9tLMUaZqfuzhWmz5X+TnWiPHo6S61q/lQ6I2+NwulXzqoCtukruXOaGOPbImXYk4H07Nw
yPumUksPBwFsPG7J0/vSm55sLLcBnz+NaI2dHPD7SJy81nvKYXUNEmwh+6G4wo0I3gvidFcST87o
BA0Ko0CCGEh0XShHbDZ55xCNVa1949WWi2u4+Gb06fBMw4a9Y0UfD1E3MDnNDPz00ok/1exkKwqm
wN+bVv6MViM/OthSdz6tIa8mOHG7daqtLD3rCIaKkgyPnTn83PFAHLHyd5TNF7vanprN3Fg9312x
5KSRxuoHkJJ0bc3EHbJlm0gm7alOxKBLLr5I2sCOeejqGoqXBk7hAE0AnMAYjaFr1Pqar+yKfNI6
tuB4qH3lbS0+UyQiLOURobpV2w+BluZkjLNuleWeyeZzmtcajC/S3nkWWPDK7if6c3ZNylqo4OJs
GoxSge9eedacYYgRlvUZf/a0yXWPM7Of5lVoDG0banjNQq2LSeTabOzBM2Y54KqiTW9dMYojcn0X
gmBauE7FoXNnr1r7lqpvjNQxbip2gDuNXd2eXLEM5sGKQjp84vuCM9OKF1DrwQONhoOLog1v8naF
RrnqpDdoHUCkIP4sp6JOP0nkiUvR2uNduWSXsWKDD+b+u90OWQC3giwF8V1TmeYPKuCJmJMUvlso
HAjJ14hXK50hRNb1Yq7mSToE/IR8IstbndorlCFxqsswju/YImCj9fpLlefjDeHYgqCeqa3MRgxB
r8dqVxDo4iw75HfNWPPcxgew0gfjw6aXG10vsuXhWjnEwbyNSMGkCXc7wa/EjvxnZYBeL7L0W+6o
5dT2jK6COoMsjGs8XRFjnLfOkpTfR/ZW4YDBbW+YTXarIJasTZM119XZrKyQC6iSbcvWfrfHXF+p
kqB5ZJjlk9b30dHrhRfmkZgDKAIwZYcI5scUzze4Bz+9uJnXBPEMvP+J+5mTAws4N4E7SGz7UToc
eSv4xGsD7Ry5hUzxKhWFy+ODrkVX8m0ZzUCXn53GT0T3TkYuEaVdVW+BwQ2Xwluqp7KCse5ill+P
jZWTaKhTBJ2ZhGphikcxRtu5Vv3etxOxpUms+xhkPGz0brqAKpjAo3FxO5Tn3Ym4dL7pRfts2qo6
jZVLNe88ETnzppQAXiRCkoQuyKzUVOFEsfipi+r+Yc6BiUmi0CpQxYR02UxpfrRgWAVxnPxYdEwm
stTijVEIkvjzWB50wh8pWlgzhYOVmKFegvbMymxX00q7aYgKBaZGSCSWPSpbJvOd6djLj4kd6UmL
XGMDXvGspdbwYAlKp3DZ4JAENrnuDbf+bkUxNUUtaSuxcOf5ieeUVBgo7zbDKYa5k9XxxU0ntSX/
e5B50l6GmCj8WEzvft59JWnmhm7HQEE53RzqCwgQX6nyMI01NQhFI8YvBh9GFWhxPT5l/py8kGrr
vjtE5zqXsyYFsDszYlqA9FYGxLnKt7hu07VpCXnoRmUf8nYabxc6l2jyENWwMSO/30WZ4SF3DrHY
6qVhB9P1LN8kcY2UJ6L7WLF4RRSB7FJ6fh94ukKla6poncWgUmDfTTXIQ7sOi3rgTsq1BYwYRhw2
jHXevEelmtDWhgglKk82g0wTPlZjPliu/9nZpnHolB9t86JlbIDp82auJp+K2Ew/OZYfn1RdZAHe
NdoXurQFaSmXLoHcxQnDgDgVwYmoqOigamTu8nEj2hqfkWPPNkHwuNNj3lBL0XNvzuhtBS6kfn0F
MXQcQR6RjCu6Elx08zy/TRzX2tQxW/BkYaBjzzlTnXxpycMs+R77qM6Dw2uel5KGXAA87RQHHPBy
KzALOhfE0OXTyjGkQeVkRjidGOo9mhXDYYDhQzOzHaT4l944fxJrS0DhIOFThLyMutCyFm0pMZGX
KSr0wEwWe1OUbmBgyg1Em59dmX6M1UJQ2E6HHbMnqhl9bUNgGJhGpCNPtL48KsuPdoWybzsFrLPu
Orafidk86aNdB60+mauFMI+2qVU0vTAnT4PS4SRd66L9ofD6fNQ8Hu8ybYSmx+4roEEh2Roits6S
QeZrRUUnywI7bWtVlmb21cSxsXUj+50epnKj/Aq+IRmCvaHnxd7VjGNcOy/AXqq9W/bNOm3lEx1q
yMm2Ne78su/XTmsvm9L3gOQJKbwtdevDprFt1t++sp2tgqb1gGyarwtLtlurKWCq4E8+NFE6h7D7
kne0/pjwWZegLMMhZcoR9RvY7kzZ4GRetLH1tpy0xrVgx3eQXKVHdgY1TViuv+tterm7QdiHslx0
9rCD9YSkgMTs1fCDEvJ7zji5t74fM7snwQdpzmMfLpG0Q0GrSchxygzjYhruFiikt9MMk25JUHSc
uJPXvZhz7KfRZtOWW/IjZ5pXr2jis70VLd7mgz5YVBLqc0zzOcY22sxA4N1W5sQDo2PIBFcRhVfG
/ZmHNcM7L6LudRANUytDc3cSkuO+0nwTFgtEnkNL49Tr4ib1HgKDvvfq2Hg20JjCfMlpyYj0BNj7
Mi4ckXElvXcRZvMsbYbQ0H1yu+TtwBz0hF2J8GcvsNa7B6Oz2wstZOy5i0yBdCS1eCUILhqYWB9Q
WUKQtko/YgrNu6ATYxmvYWxOZ4EhYm0xd/s2JGQhRZsU23y+DqSimnbORdO6uzrKzWMRVc0jZKKc
3UQ1cxZkkrBpEzEec0E1XBBTg56Di/CZnyy5YXxXadGdsliVn3pJT2WQiCm7HSETgvikvVycyqFi
E+BRcnOi9hzDY95KL1kDADRf7HRsf/TA4IcAMGd1pFOHB/OUuZ620mjYvq1USpi15cR9AilA6K5z
KbQIDOWIXUuK8juBy+y0sC7+AAgPu4x9mADBZfNcnYC7RoH0qS4JnLyrjg2kL5QiasceaQOyn/2i
HL7pVdOgFkYxvZz1gF1GsVS9y57k7VKOvF1JbTkUOKy/ue1az4Wftz9s29bf+ZJJfIGb6jbK1K7t
OFlDlNL2Yg86ywAdpbc0LFv4zL2w50iHfp9Dd0ks86Epuv4yJ7pFE28JDnUFB9U+J32JbUEBm2O/
ZCOSr+llISHix9MTyEW8820N6tO0f74vK4JO1TeZnoVsMNu3fp4cH7bTyD+bgRVPVRO/ieH6ZPgB
1Dky6ZBH/CTazRNtQHVkFvpWlbN/yLplaQGVybw9x5WrUyDXT2n/kDE53sWRHsdbt8Qxk45j0j/Q
qpYbIRFAOywz5vvrsbaKB2aVcb6nJi9Jg4EBrLUGV0pIcykr8K+RDxs0Nrnr6bW0unXfM23lgZDg
ny9nA3i3F5VHV/XFA3XBw7aR5eRsBlfygfQwJzmJYc+lA9kB7BBylWZGiHeCnUXZ4+LJGV1R8Rij
bgSU4hYPSBoxBXHXEzQVrECHgQK+173bH9DPs9Ane/isT9kIUcuxJ+ah9UC37zx86xV90cY8zQdB
NVR69HH+XBBk+fE5vc2s2phXvMHnOuVEH52nmgszIKqFJ9uXzZsgiXf2oZGdXWIaYdSO2Q6MEY6e
yp3jT0OLs5MzZz3gWeIh46YTCE+k+zggbXJES/Au2BBqZowUXrglc/0g7XPgHEMquRrjyMGy0nv8
z86K0pNEGn9GEUhTKnjoqiGg3E8fte+0j5m6IgrGyHSR6CztQzNx6Du11T6iamoc7uZarFMvt9wV
YRf11OlW90J7UBfkRuU9c2YQF9e64uSK3D/D2GB/0Ba94CFfaQwUe9YrHDTsxyPzahwtqGYO6VvE
Xd07ZqBPGvvKgYX0wn0wlMGEOJuDcCiws1vGDJ7RbCKGB9LyrHgrXaW/NgXwqQAecvGAgsWV1VHV
9eyh0NNY01p8EW3mMJTo9IIvM8+aI21CPrNqylHv8fvx3EUMLm9Sgg7rdvSSs1/4xa0/VFERGhG6
6kqbuOkXvm8E0HKeNpjZZpj4ru08W23JRcAo9A20nvgurCQ7JU1sIkPOiuVBp4zoPGg2lQ8FJ3PG
6nOazcwYdG6eor5adbNmgX3vFI7/mCQal7wLCRfURMuXUEkmR2FvS5x/lG/DwKlMDyvg6BvlDo1K
PWlemu10ilZuwJkVD3GKj6NQXLg8FqJz4origRbP9jGHttcfUqd3v3PYUYBCxoF7Ix1Io7AhWDTy
ClrNzgyEk7llHx1nwBgjUAQLOuJrMS8m+6y6Mfu96VrJPY+iVqy9Lo+yvaDIctd5bowThfsDjAIj
jne6hbi+mV5d8KEM29mp85D6SlbdfI5fmU7xcUIMnasb1Xszm44EkoPOxCgLf3qYJGbIH40e1yYU
rJHlXjQWl3CbXe/voeGgc/GuiZ9q7vPw6msEPUwQ3dwYuWK950X4of6swJlT3bVSvtkBXJuB0WRR
BtrpujJXPABCf5mmk+7Qee5XdXNPwREcj8WgIpdNPU8gcL8nHcVZ35pZNZ+pMOn4DIiAgDKKaued
WrIi5QiZCERUdPWrQsWXNJXFsK3hUvJULSnGC2YzE8VNQtR52w5tvdfBiez9WtMPw5LwXfCQa0TA
F4zI7Xa9FToT/4TTkrO2K7pebgpHsEami8U65wBeAAzZatYzR0p9W2QYe5xYS+47ru+bdsqjsyKp
uBkSZ9zRqMOwbGJPHZT1woc0m2k5HN2x7mkxryqU1krzIu0wlzoghLrmgjNHB+7zCMl3C+eJXXiV
t2y2AdExkmFcgwNHLt4qs3JWksr1cLcTyCLpMsj2EZgO9yLVq/7N2IzUzifc+lHra4THy65dq64G
Tej0zgE8AixAy8NhahqN82hzdW+Jf5eUjxa181HwQGGXbCztjhz5OSsxTZ0YhfLIGgR5k8omAMHm
gcbRKbN2MpscHEoOl8rIhDZoPCYfGLt4XkCWUk+2Pgj2jR0PKcez8Npac/HARoviRrY9XLxD5jOj
TBrPTGgUK644R8ZgNLvl8mZux2GlmgRTRNL3JLqyybhFo7qRgGdJzENNpB2Z87E2kYYBQX6QUvUH
pAl+Gyexoj5AGtd2U0G1zqp0R9b4keX/TnI4AipRT71+zHy+u8sSGQRoYCc19gZ8RaqdcR7UNAzC
vnBWWbv8d/q0HuuS//zva0r7Ww3gII2T4Sd19///23+Nfbz9qi8f5Vf/64/6w0/u/8/PP6bdZv0x
fPzhXzYVycn5Tn518/1XL4vf3sU//+Z/9Q//19fPn/I4N1//+Ns3OCTD9afFaf2HhlEcof+RQri+
j3/+v65v/x9/+79dSSMpQYXfftT++z/+xt//LYptk6rGu6/j3tKFbTsWHkP11Q//+Jt9rdMCWoxj
ndAuxVk4WP8ZxbaNv2MjN1ilPZ4P5BiwePa/RbEtj4ZT3SYsgreTseK/Rzwmwv0Hi6OrC/K7xIcR
Lonx/Of4bif6AdUcid7r8KLFfZOsbYE7tVnADNm2wKTXWjCsODY8War0tmSr3qkVWnPkPQNTFESO
nhHy9vHcvFizONA9cXTreZ13xm7oLI5g7U4paHazNdkhqvuqi6vyOdf65MiDds/mZ9WXfsQgrhNr
A2DYu1X6uDDiPgRJcheJJkLtsMzDlBtnqDYfRs5Ii754iJFoLih+GTPV6RNCBZIfwkmgwQSD0luy
4xt36ZVlssj+WSMLxoxJqX3rZOZt0hmIBctyPwzONh7j7Izm7d2LrJR3KlsyVs2h2ABmNnZT1w4r
TXSbHo/Njawf+qh+0qlttWxNv4MmOwAzyYDkSwY3E9ClVZ+W+yHP6jCL6MS7LnBPvd7cxBEmFr/M
L420BqKdcRMuaOGf/aiHdPBk+9GVEFdLDAZGFeG+1dK9yua31jQd9qkFA/ZyOhF6AiyPsojiDSwF
d8V28sgOySWWxy5nkx55T72tbZRbAg/ps6cJT8autEbjDhme6YYVM+tHoTNn7b6P3upxhn0MKQ4g
DkYa3XfX+jDvh8V9gSz0ZZl0QF7Pn4HvgFZpm2qtXPoR9GHrKOu1KlGujWR5jxiJBmXBvAgO6FWy
kQ9mWqmVW/WcJae6e3J1mPmOhmDiYdt71QTuC6PXn3zvRveSyzxwgM/716phHsbIxTcitetEfMJ6
3ASQg7pVHNMDnVVZMMw6MJRrEemiqeF5LDy2g71eIao176UxqE8Cw7hbteJp7Nx7bfBxgzjZcltm
bM5qWrpXpUhohJ4yZk+aeTIhEazxtfM5YuPFy+Hi+kF5isyx3lxT2kaUfVX+9Xg7wdwoxcGqS1yb
GSoqAN1LpBMz5mS0znL5menPdZc9d15erZjKjZ+Q6uFYM19aMS5CywXKdGPGVC+UOiVpuab6nTsl
4/M4z9bB9vV503JJhiCo78kUa0HrFfGtVRF0y8j+oPPkTsCsLPpKC66YNJqePKFbOJI762LhNwxc
4VPrVYCB9Dgm72K0EzSXaL73HBMqFrooD868MoJIxPYKFSU7+u3UfqOsNj+PBjNZpksrOWbBSOq4
nf0zO/TrtLx4WixDBCxf7KftbQLT6G6ZZPNaTeAVClsvntwRzl3C6CosKNQM5sLjQnHAl1uYPR1N
3o9UppwdAL7r2W3LO8ecP307V2fPrsvDOPVYfRHKNuQmQEA7xVAMYScWDGezxD+kV257Th2chhDy
+ifMPjyDY5Mhk+tULzlBp9uejaeBz6MTIQ3GM3VUjvymaVq5u+bFK9zbTsEJa1zuSCBn69TgEBTY
7nL1MEXGTV4xrIUaRkcG8D5pXi8YMd3nSTbdDJVQx0K51b1rxzCkGJO0NmC6lqlHquI0kJFIANsy
FN+O7Ic3qnUVVs2EtYqtoP2uYQ4/yKalBAGliBuJoh5/7VRdaXJndtYH7DxGl25TWKEx0zGMurFs
jDnDMJjlKKtULF951lO578Xkc/6rdX9jTH3yXEp+mcVzjdWo69pJFPOV9Bnx0adZ6jAlbNXtZI7L
t97CHJQWk9wvTjp8Zm0N1qkaIhXOsvL3Bpa6ldTa/JNDBb5Xt1vgwGoSCTmmPwPrtYjOHWUy4YK+
jxZqXrF7iIinHv+7DDBJouXYi7uiO9UOjaY2eJuUzK8tzCnHTvbleuT33ettMt1ZyyTup1bvjnbi
qK/WZ/+Kw0slmxlG0kr3q/kJZ6u2V7OJd90dau4qL5MuXpXq+9wn7U535XDqLD0KqcY2A1vz/FBL
svZ4FdDWJUvxxXQ07zUG+bbRrn7L9AqQxsDuQJHWspKymKKMPlqsSuaVijy+Z0p4N6YZD7s2N/o7
AAKce5yx2EYscUHR6Qzdcn0ME5EUIKocDd+3IfdU5UwgvvIIZpfmbjtEAOi+iFCA8svB+Sr9zDg5
UIvRZq9H4BIQ7LosnPZJq64dURzeV2ZPq3As/VWSVIyLgbSfBm/qz1FP7H5V+jNjL8ERgNE2AB+/
XjoUYNlvQW8xlTQFZDhI+0y401KHwGEna6nFHJBIhZ1qQIyrZiR3oNMY9eIlKcEPR8/vUjCqQ5QY
YYzxc2UUHpgFOMUhhnlA2o1mbKahdl8R+PvPWUuzx9jyUPilaR6J//HT7SsfbJ5UE0rhNPvEkDH3
fpqTn9WdJuyh7t9qsfTCK+MISLx6onFt2F2TF0GDBLyahV3esSNy6ThRaju59rCuS1a7ohnbUy6x
FEe5AcRWLe5ORyhfdyWGDi9xEWfz2nqfF6rQ4xg5X7NwMVha9ALlf/5BX3p5kmbZAL/07zioj0+O
JsAK9z11lWpj1MNbpPHYbgAL8mVAiqimvVTernb1R+lpm9zStx0M6T1X5dbyecYmppcEVy3OHuh9
sSNj3TT49tB/+rUdpyD9WpMDemdiRCTTgdP7NR4xLNeMzc6828Bz5CtVSOvInuTal4LpGwacr7Ff
8nsUyux5AKOEXJb2r5HAdO5q1U1J18KW2JZ1zmelh4Vrpy90R/j3czY4K2oynE0tlB/YaaJWTk2r
FZuGe/tqDVVssFLH2oqp2hguSjli6E0JeLzsqOrh7lvnisKpOhFhIbR7dN1oNbXAQjT7bda14dWJ
s7cSItXJYWC8S9lZNXJn0ablOX0IVUBeJbo1p+8loCGzCIeS6MKSNPuxjX9oLQZ3agaClsqklU6L
+qpKInBVPZ5QO9thbC7DHiF4VdugqkTrpLDo2kddB6vualdzXh5tcuqdcEN6q3Zuv4hFrAbV3k/l
AxLPjjDPm5/SLW5ZF328AvJEvHGXmWO2s5X+d0ic912Xl5tW+UjarPJraAQ8udUFTsAFx+mbTD0G
HPp4i4U+yDPo7kDs8ThP26EVG88CciUkOEHMpe4xLcow12cmsr3/pGEcDUx3/qHTpbPB90gf02hP
a4ZGDK20DBen7b55prP1RoENQssPDikIIy1/tLHJH6qHZsTxTJa9aS+gI0LqqX5MYn6SugPxE8Qv
myGIwuiljub0JwEyYZ2O4NarsZc7E6Q82rvpb50UhykPO+1Vp298a8eK50sfE6VgRDs768WfrZUd
58tO0xfn3sOh2PRSkaqJ7mrzin4YCGBuB1q1VnAy76KU+ivOwNXB6fm4qiYFLDDbx7Zjcl0mrODc
Bpqr1ubsGfXGaItHnI3YN6J6fphN/Oq1kOzWkvhUuH2gNHwTlIb8GKbcodBoFHsGjtpqLmovcDmA
CwoFFM8KsbzE/oTebbny3OgZaCHoau+W8I6+BpN68GP3iPUF/Q4YSf2iOg2K4VSqvUPG5cBbX3Y0
fVt7BmSA4Tu6gLl2oyc9MmrQ7r57I5NkCDKQ0gcmaMkaxw9NdOmorZrWos8E+N42LgakpDq5cXXG
rqIYqCv3tfHMWHP86qRs77GGJa+kFPrQHPTlCNNliVceIXcINIjdfjXNj5HHOX5jjnEZNH7rBwBN
Frz3Lg49i64vg+DHxVajd+jn3A7sjt1nb8wFBm6AGV8A1eQ2k9WETrnctgvj0bVlVsal9gcYHk2T
HZQXGcfaiiJiHBUtXUo3X6S55HCtRHZbsamCPTUMl6ZxAEFqYGgahOI7t85c+g0K7ZUlwHuXee4c
MS8jcLm2PMJsGqArWjg95vwjstjzYiivdrbbaru4Vcgyw/cyrnaeiGQgG+PZa6ptlqQb19zOS/oC
ZvngLT8wkAU0Mf4wCQwiyGFzlGazAW94wuW1M5GzI5OVN59UkNXR1lvAEGre41COX2yv+31tJCAe
bCJpQC5C4nM3SX47G9ShCDZQYz1vCdVcb9M5z8gjIkN1aiS04V2TCH5BVKvjQToqXCBYoNnvA5s1
h/a2GMbB2sS0sG1Ehx3Eaab4tS7S4aDKJd5AvfY2zCRvuxQUv2sz3tX1hN03gc3HMSoyago9EX/X
U8ZYsgfLm4uxBtUqcjQdUbobK12Ku1Qm4ibVxkenqgtc1tSJ2sylrfZNmnatSIpPTRAxF/+Uluwp
SYSbCECjvXI7YdxYdVRtiW3ihu5ltxmMUn2ZGB6YmzYR1wF5+pOt8d7yxsG20GRTiN2wfm5ytziZ
bf2UE5l7MLEErFtDyzUmC1N/4iHIwyKuvYPsFQc+Iq+ZYP7gcxKfbZfBd9zqMcwQW/9Ie4lchXFr
2LZG463hP9ehaJX3g9YhLfSkDfEYc1W6yxn/bjtX+RunoSCmixjfVfQurCankduELOreHZIaB2AG
IDKr3YcJos8KLsUImx572eAPTZilUbRrq8L91OYhpuAZ46GJMrJSJoDzsWiT7oDZstgK1g2si2h5
+QwHuVVYg0g9ESDkY6Pf28U4X5CG0jpvw+xBveKwqO8HUS9UN9tU9Vld3+MrMSTRwX5cPpaYxrc1
+S7rkmQlG3LLnVmZ8/GlZ6XAN8Vwe2DqQU3e3LNvG6sxTMUgV4wgMK01qXeq2XBxRFf0ZLpJ8SKF
P17vUONN89i4rupY0N/DTLsPOtMmoYOBMXsqecQdsDLIQ+KV+nc3kqXBRED6B5NH9LFcHFggURdr
lxGjwCbCmTRvukxEh3IqzmJ2my+zLb7spstWS+dYYc4fBlbhVue0FeOh7yqSeJaJjWgpOgCaWIPC
yuy0R98ush9p5jNxduNlW0UUhxQ1FQY91PW7qpDm0dT7dCNjXT5lDAcZqTikKjBujNzmZe9wpM11
0t3tiC6Lx1i8lSiwrICqyu5ExLaCtJeJi59t7apUHgJTrgpg0o461tPg7KzRUu/I9yxvtT7Tt8QH
NbxjZ/giamretooBDuCH9uz7cw6InT1ItmAe5EFkp1wIiToLz5nX/jx/mPHyBgruNk4nFkutPg4U
0c2ldH8LJ/8PdPJvlI/9mcx5+1F8yN+LnD///m8yJ5Pvv7smKieZf5RO48qV/E3mBMD0d4P0vGBy
j5uHo8B/yJywKH0bIhWERA+S0LXs/Z8qp3mtg0MU9QALMa3kL/w7xMlfNE4f5g0zIldw8rdhE/yk
q/wuxk1gIyoZVswnn3HG2sBrtkpsj0G+wW5mbOZh1dBpY6dWufnd5/MvYDTXpP3vYuy8sHPlEhqO
7zn8mr++MElHgaVXsRCabIJoYuXG1IBS96aX/UVk/hfuzW8v5dt8xpAyfIcP7A9R9evKiDhSdaea
p16QD6MIJ85Xf/EL2X9MxDOvIh6Cc0YI8hII0Pr1bfzuo0xjRtUY+eSJKuN+pXcevcK6g+Qzs9QQ
/1ahkxeoR0M3eZvBzDgSTsJOioA3rT7gkqcbY9GzNUxJZiaL2XZbbTEJvAijhmRP04V501oSQ4iy
9fatRmTmomP3V8F/fzLGuX/Jx1Z9H9NEe3M1YgsOrigHBm02XsaO3kvSxsl8n5Wm+WRL1b4NseEe
42T6dPpMvwOIw151nEglzZHeMv2lVe3dXwyt/ve/EGicruUZtiVsw70yJX73SZlGX5p4A4ZTzj40
9MkLrNGHy+DPr7Bf2CjX78PiFuIa479XHf+PryLIbMa98voTftPnsV1b8pK0qtnSRtCv//yl3H9x
iVmcPa5UNRzR3JZ/fK2ecrDUIaZwinCmtTMWNuS8FoIQs+pCfkOuvA6d/JyK2JxuNqcL5QjMccb6
O0imwLcm3ig929M38xVr9ibBAF1eR9ITT3eaLnwasucgoZvFKZ9xVq4l9RTqWg5gnYzudkwP+hA0
PVNlIEv6O2ffjMcbz17skliWElffxDTW4QIJUIdCbcyuLm0jIS8kXnqKZOv5DsBl4EenjIKeCe6B
+IqG53nJjgrKBVU+hXGImO41xqWk8EiJ0PJitu7sE8SHS8aEI/qukvcdPVN//uH+RGL9slRYjIBM
D6IiqFDneuP97nKhYLpizGog0CSpseVfQ8GkkO1c9YWEgmEKCPhJxMtH2dbaFp8U4Z9hTB6NPL+k
VaOHTpRQx5pE4khyk51lpGPKlq+GaYaj/TUasMOLzF7WbFy6u6zX09uc/sHA1+yHwTXoqubkHBjs
NQNPGd+LBiglPIvxSCDIPQu7b1d00hlrnBrVg5ULBjdTqvimqnlrVk3yF/ANk6fCr0snkSaXBdtm
CwnG+I+fR56ZepNJQSa49+DVRNQlsSjNSGuLE9iVNf7wFUWwCbPXFW4C6zXuK3NPJPxa8kcsZ4yY
B6eEAtZOJ6NA82yL4MtISAP3TcCoqN5RdsFPlmgCtp3/1RdqXBlnv36hDpw6BGTKL73/xDuUCXKc
awynclZ2QGi9DfrYF1tcojaSrqq2hTfnR+WxW2kM+eJm5rz984vqXzx+LC4pho8sp2ByfrmmOE4j
cZi5PGkeppKIg/MRTBgiBIjyv1iH/uVL8Xz92d3KL/3LOlTZSUuvk5QUQHbmarJnY1Oauf4GwCD5
i1vlV+DvzzXPpe/VNLFrAAH85bV0Y/BQOJr+VDT6cCm90qM5prTu1DgobJ+etULjvMoJ1OxBssFm
aHY93Ip63rlJ69DiXAvO61l/6YrS/AsU2U841B+/d7g7PB51nQ0HTLBf2HeUBi5YVYz2FHeRuekT
gRIndHTbrCcIpymLjFbsoWwM1mvU/j/2zmQ5biRLgL8yNne0YQ0AV+TG5ApSokjpAqMkCvuOwPb1
41BPV0koJdOG57E+lDW7OjIzgHixveceG1tjSAIKYYdhvyDSDyIbOJxRYItkc6/ehtakn3lW/1wO
kWjH7G0LwxRcI69oRmYQRkKfjApBVlc+5CSr7qIUYRcUseJgT1F6TNpZXGsGnuS3X8jlyfzWNyYr
Id7GZeGwAMyWQf9LkEM3oUmbnKurKW05vJjSasuB8Dn29j8/hZUeK0v+w9YVRt/vn1L1LufFY2Je
5ZQiUAGA2SAhu/MMf+ofMy+pP1yaUyzHEo+QvRpcIlS5kZr6+YosQ3KWm+ZCUpDgsaKttxB8/v1p
/7/p+G/2B7+8RP/Irbgtmy76L+as15ffth7L/+s/Ww/1XwJxtAupSf+5w/hr66Gb/yJ3gt0DDE/i
heAZ/ifDwvgXx+Gszsia1nh4y0L3PxkWNvB8oOauCR9fZf/xf6Ld//4yKsvWw3QMa01sHPo4rgYc
5g9UZiUXHNxqh8iZ1TMwwFOtrxaXtgjARgS1cl8k1ue8a6nXz+YzL/iptpcX/5dB2moS3ruRI7Et
kjucYg64cvt/3+eTANtTja/WkEbHlW6u9wHHC8mXCrjmsaDSZffLG+L/O6CcZoD+3efLh/7yzY2+
zaw44JuzIiZX3tGvFALEmXX97zPd342vFiSuNZtVp2Thg4kBZCcHpXzJCtXdkg2mn1n8nOqcVXgc
+ARuEvgIbZLjFRBVEmDU4Ayq8lTjvPC/do5TuelILnpwzz06ACbT/IR7lTH3V9rTHzr+VN+s5rwW
ygcpq7F7T6qg6qVNSmK8hsIVucKZl/L3ueuv3l8s9L9++w6XI1cYpgOkrkJHOlScslotkluur+/I
hIOFosmvimqnZ9ZQJ7prvXXPluueLsude64ebueQlJWMg7cz79KpxlfDl5SwoiigJuBKFV+UrKeM
qrGe3n4WP7vk78n2765ajd/UaSoJJr6/b2ttp9cxJW2YyIKj3n1y5sfFx0BSRZLepXXCVTj5AeEF
u7eALI+Os81j6X4L1HNTsr586J++zGq816UGHka0/b0EDDBUw34Or5T8YUhuyCTgjPXrSCLrqGDN
1Y+982xzr7BoMjgRvwzU69xd5NI//1H31vLv5CjTot7e58q0U8ofRuCeeSSr9dvf3bY8q1+Ch+o0
QU4GTn9vKNHRML6S1rER9IgxXjUU0A5kmyBV5zh5u9wvy2qjmx3wK6iThXuZpvWZpdJqA/T391jF
mYwbZG6Np/xe5QK1G1xvoOccEsgxJfZcrtIJg/McVPdBuNeoiaN/2B7aJFgkMMIC8uvGDmCHOC5F
AjopPOqZHrJPjHJtFZ7yyU5jqVTxfQ2GwtMb+ziM6jPZL2TrJhiDKGojYVf3oqr6oClcjeOULe4D
XIdUbVy3KmUelXsdV/mza8QP5J7dSDd+xqr9qLTkeMoc0ydYm1bfoG+7cjSFirgGu0HUHrvAeBRD
8zXN1e1Afg2gk/FL3ec7LMVb/PVXkor+5eqgcZLLaJ5vRTd+YF1wqarBQUr7Sok4ICCJeumxWAtI
BZ5u214eyNynFq79ElMCVFQalj69xhjeHKKY2xvhSviKzt7K4u2U4X9UUFRRBNxYCZf/Q73Xs/HS
iivK28tD29dXOD1uMUg/ZFm1D3uINZMM/Anw3ttj+1QUXMVwbcjD2urS2td7JrhoZOtIWn10kJkO
J4FiurtoNlDxyf/b6eLfL+M6sI8zU/+U8Buaaq/HzT6pz52RnoiB6iqiL45v0wVD7YOWecbOJTy9
OoegPtX2eocDxMOhEKD26xp/ZSSCW8c5RyU+MQrUVezulTZPKtuqfU11KMygNiq6T7ImuUtqQVHr
2w/61A9YxXCjMCayy6bWnwb3XprZZaKm/vuaXkVkagZgGtZ2DWUMBd6clQ8ycc3t242f6pzl9/wS
RBVrkQgbYev3rjNsFIsrRw2WyCHtVH339kec6ppVfBw5+q5q4DJ+p0w+9UYj5WXIn9/X+CrESdwD
+G/nxh9s5huX8s4LThGi960p1NXwJT8yaR0za/1szD7bM0lcInx93xdfDdTcjaZ4qfskQaGfN8E0
+6YKHOQ9jQMa+v2pUjTJbTkeRT8LqB13+eabIrc/v6/x1VhNDDABpsuNfDq61E/FLoJm9cxa6M/v
CseJv3/xTG+mxCzjzs9b51A0Q0UZf52fCcanGv/HGJ3aOnVoXHeDfdXq8waWyLR9X6+sRmlAVY9M
DYcoQ17pRS8MC6km4vO3W18e3D9XZRyU/N4veZ+n1hC3ne9KEw3mXO77LP1Qp8mVls0/Bq5WUff2
voUe9Qwg/FRnrUZtK8SEtn7prCr9wfu0QQfQvmvQ/sMw5ZY2t8pmx/1CUxHtlwri0jQv3u6qE+sx
jpR+76tOj52Q5NPK7zu7eClyS/mMjp3SgT5wdnON8jLlNeMSotZvAcOTNldPFPSnlvbAkqG+K7iT
3s/2JB9HePm3Gcdj3F5ju1ZAf3kym4brZpLfU9EiU+o18c4XaBUQujS3xxEhqV85zms4cjLFZcyZ
tv+8DOEg7/cuIUMhWMhMPEwbVnNuNYBjDfuTasJmGEj7IM9G7jicbY9vP4MTL8/aOAVcO3e5fOh8
zMme1pCHpnWk7r+v8VWM4KAZnIZUmGonDN5KY5OT4hCb3279zxOi6ayChGYo9ZzJqfMtMm234Wzl
V+bQ5RDWNO1dEzoX3L8/DZlYLZ+bNn7ECbfXcd26s6kWOxMqTvX98vdfZnSKYyn5Hp3WtzsSLkOr
/S4mrjLe7p2Vsu4/60sOyn5vHWYz4Oy4qX2XO7Gj2pUaRKb4m41RxDPqat4lY68cHSdKb6ZWB4WV
GPUui2z3zBc49etW831pY/o1RNP4c94+lFVzRfb7j7d/26mmV3GjVBKzafKu80vb/FapJsXV/fe3
m15SJ/4Uv53V4IbsYSDGgyGRlKTwazVZ/olRuOxXFT32wJtg907AlaWJ/USRC177WoOJTLC6VDpQ
gKSsFweXJP0d+VqSavBCucljJ9gPOGbY3UxkSwYB96B5x3QcpM1h1kW245rRPcB9/lj3Qb7V5oGT
bvSBO/BNtRc5keUR1cNNrwGWJfmm3brjYOydOMNYg7jm3pmWvPCMPO5OSKgd7lJCtVxU5/rsPKeU
FrPzC6I9uXz6BwAs3XOQDtOlVlvVdsiHaTc56jc5tdRmIUrfcolQefMAa8KxBcAB4T7bfT4CTXAo
zW3IYo/H/usYK/WmzrGjv935J57r+vapHRSqKsay9rscxDvJkfOSAXYm0p2YmO3VeBAUlFJC2lf+
GMLGnmLUzbFavNrC5szBKYAmJlVAEuNS5g+fMDyzMD0RpexVQO/RY7bcZ1Q+oTw6tgHqesXN6yO1
Imc+4VSvrVZ5uszwMTlqRR1scK3kAM/QOWpnHskSTP+wnFmnWqT6QO23alY+R/HQ491mQHAALWmM
FKq7J6it73v0q2A+zmleqbbW+m1V38km+KIW5ce3mz71BFZBHK5V7kygxvwhyo3PQC5ywO0ztT+C
fN+3P+LUI1jFOjDYaWHHU+WrKG+HavoOYO7p7aZPfftVrGsqqtaHkDUSNe76VScr4GxSqDcWm+Mz
z/jUR6xCnjT01FanTvh6rLqALJX+wrAbuOCI7d91Qv4P5aRUpD01ky58UYFb4w4bANdw5nr4ROev
FaGzLWrS9WlbyRrUEUlzU7XvO9k3xWoFQymIDBFNCj/JNg2lJu/bDJvL7dmvU79NYv1EAqzws747
5qRvhYb7vjWLWL3u+oiFrmlV4dsxxf5461MvGc4670519vL3X9YsjavMwcT1s19z/b91y9GEAhRd
vv2un2p8FaKNYexrK8uFT0IBGefAYAP062fe8uWR/SGS/Zzwf/3mY91RyFUJv4ZfeItolTowiDAX
wIaaDb6qwaOYUNm+/UtODCmxGrVYexu77Q3Ld0Zqgd2EGkAAjsqt6EGmvf0RpzprNWqBiabw9TTL
Hypkf6L+pOju67uaXt/yhwB59aqZeMgYcChobTUSHrX6TN+c+OLWar5yRBdRAST54lPQe5pTfOgj
7X3TyFqMl0auWhtgev0iKT3y+kiorsznt3vlZ5rJH96gJQ/313dfoEGPEhKS/DG5Ljr7oDrop8a9
XnwMItjv1Q05fFTXHsb8VTe+ZsaTas5XhjjabeIt/62+jOd0Pwdn4t7KYPjXCt9ajXTcbSWVGbnt
O8HgiXEEzpxttaVS0KV4KLjmosKUd3adHNP+tiiaTQnlUtbmYUQhVC+XGLUozoyuUw91+fsvo2tI
knIWIit9Fgf7MrPARzWU7b/d86caX8WFwuxi6quL0ieNHkRTfQm761wkPnGNZq4TZ6JggaRRnuY7
shu+WVEij3kVvnA4H+8rSC+eXlvTcYyrr1HQw3quPlWF6jyM02xsKvhcuFhE66VpGFOdxr1V2Wtw
bCt9uOs1M7wvW/49wM/2BcD/zzGMMg9P8RcuG26Mus7e2UOreDNy+W/JoCl8RY1+6HpEcQBKtDON
L+/3n977VaSZ81LU1KTnfk1VRDl1ZESwsfPcKacwYHjfyDVX6+SBG6S4H4bMt8PxRcrwqxg+vevt
WedkzXYLP0vpcz8YXViJiZ8EqFPebvunWvoPfWOuFghxB6owmsfMp+ioO0bjrH2ocCfeoHkh9T2L
wyOcRmoJQZI12y5UxtvC6LKHWZJJ2w5Vth/SLt46QyK+LpbDa2fRkIQxR4cdO0FyIbSPlj4iWO+G
17ExOsA95SC2OUipfR6/70Ye9MjvozfM5qCTRU/ndxo1VNGBHcX27R46MXbX2sJ4ngsja8LUZxQd
hF18srrsTEA+1fTy919iju1Y7FyzLvVTp3h1K/dZE2dC66mWVwFHHUbNVmWZ+GFjIUlr4ZNESnt4
X4/ov39ty24ccAhD7OcS84MWkvk7yfrcYF2VE/w1K/z8+y+9gurDqmZtpHl7D3xkw6qGw7H7gvr5
bp9b5JAk/U4tXzBueGH86traITdddvbH5dokJV05yixSlgfODz45VDFbEORDKJXBgEpG+8A43czR
xzTgbKB6IrGBNTIIdv1D0NfkZIIil8fOeQZ9RRnj/t8fq4X25n2dt4pFg6roiWZmmT/O6lcK0zet
itrkXW0bqxDEbbQGS6tM/aYvuSsf9wgZ3vfMjdWaJ3bTUChpkfpBHV4DT7mr5PviprEKQEY4JFE6
50vc5MjHUcQuHLPH93XIKixkBJhoskTuW+IYmH79zvncWC1cyjwrtEGMqW/0GRBC0sqOlWzs/fu+
9SospEFa5Gw4ab2EjBnIZ87lnt7X9CouFGWdp3lj5r46A4kJZVodFEgv2/e1vgoMkbWQUHo99alA
KLdtmd7C/3Pf2fhqhVCVulBELRN/ysInTUTtph3lORP6iXhprEZlMA+OMcxj4U9Vke7DBhMJ+ox3
9Yq+GpWpqZL/xqrW1xK33fUDsG2QVvrF+1pfDcyZU6dQAAvwzdp8ypPia1Gx1X+7be3nEcQfVgf6
anAGyDdTKYrYV3XlQCC+Zthb4hOx1qqdo0oJNTCrdjwuMXqc0Y53T4KzWJ289AnZzGSyxc6V+7Cf
d4Y0DmAMvaH9bqQfaSHjYNjILCrR4RMAA4BSfsHZr2fm09HQrmMKiBBjbBCclOw+BbEdf5vXdbDx
Z58AXhXWRSmP4LGWUN0Cy4EFcOAvM6+FMqhH5o/aiI6F+DJS4Qfl+Yb/UU9/Fll7nTN9dYLvqvOo
BRpU7Ts2u9dMBpjBvzfj0RbRluiv8LCcUmyQbizTQinhCEbmgU+v7e6DFSK04YfEFTVlR1Dh+DNf
g6ni+X5rpbUUc3s0qXEWrMAw6RPYg0eS7nd8D0sbydziCDf/dzcCeFAb49BBC+Xjq7ZFaEhVL5Cw
VwxYezqE2aynHDjITKxpGCPsAHgY5id1j3CO/7pf5rgJvk/eZ3elBu5rrJ8Cl0zL6gn0ZjpgN2Nb
g8VyF+riie8Qcr4SZvmFrj03gEogFX+OzfwqgAyf18A31Gg3h+h6uhtdXMNt8yKwOIITVIlVjXz9
3QhkWWkQf9CF2ohDrD5KdS9htfHNu+5zUlBMPkxXhdpus4j0Qei7FUhrzdPls5OKGw4BPHVWt/U7
DxV+bpJ+WTxEA9e9rm0lfpuEVK8H1hc0NmeGw/LS/2kwrKJ+GLV9rlZsI+xu+Gh3+sANlOx2Rsmj
jBuQCPFE3eLbQ+9EQFrX7jmQb5uenBA/hY7RW+WjGYqr9zW9mgNqdBBpIdvUFzIyIYQHtmeOuEne
1/pqDqjk6Ipw2epyY/MM+/8Gv8SZM9if+u4/PYDVFFBzaW1BlYv9gncftfJGa4ZLBlgkLXRi+2XF
06b3wG8ofruIZu1W6z69/atOPfrV/AC/s8hGqK++Y2Q/uPNSfIgI1UegrOkP0DnurSOnc/ldp37m
Op+5mQJTQNGKfYfq9qsBsN590QZQcQJk2lIq403hICcLkxouWSDdhU2sucfKaJ1NwcA/on/Rzkwv
J374OtWZMqEMOG1e+GpSVjfUQ2S3XetkzzGocKLmFO5kAnrw7V4+8dJrq9nGSRVTzFNS+NY4vNSZ
85xP4cvbTS/T4R9enZ+Zvb/EhawzZqCxaeJDmQff7drUAgPEp/bOiI8ww11kvNm01TW9fN8W7Gel
2i+faI/aFDjoeHy9SPoNCS7cNmbvvGjUlh78pXHHtvTc4rLUT4fyc1FUL7mqf3m7p049hFV4MCL8
eFRVZ36dTp/wen7hvPPMy3Sq6VVsmKSSdompJ35nq5+CNnmqGxSM7/vaq9hQJm3TqaUGd7tXn4KF
fVl3ZxZw+vLT//TyrEY/Sq4SgLgZ+42t42OZ1MpTkVV+bKfJ3kWJHoeIAxxul0voortsmO5t0wZm
7Fp5Ak2fmt2yjHTsCUqOr6nudwOg8V0cuvWWQwUNv1VoemYfYmngR2wHXSvSLdK+4MwPOLWlXufT
Nvi7B61yI19S65la6b4gkiTclRcpGorinvXMREIF/1BRHaY99wmLckg8LUqUxPKXFdVMIRGzejv7
evqxyi8TmEhZkh74G5vqTuQ7KC+7RUfXmLtl6dA7wWZZbcXGlzx9kHguDZM7+da86Prvqnzu5Zl5
4cRrpa6WwAB11MpK+HUsfOPpALr17VdKhzT95ye/Tuht3LIZOB1N/Eyrog9TXMk9h6fzoykAwPVx
BvrLRcWQghHfaUMWHhBFKGSTw7Q4UHc7bEi3DljhoLd1rS7QN6RZwLfVI84rFNwjXtFqOXaIobkd
mphD71IIr4ftdDAkLD4u1vrbsbTSa8AVGrUZFu6XXkcvWIlOQ3k8UCTc4VZtwly/VJuKlUibAJ+J
yDnkCZnKo1O6D2qmbq1RgxyOQMAYDSTuyE/hmE7Zxs7AsdpRBdQ2KOzSo9S82hZxbFwrkWuwkp9K
ZKe58WgO5ryf9CLdgYWKfyhySF4cdxCvfdlXr1GVtHezUaa4INx05858CVK4IapL6pcDONE7Rojt
oa8oOFx2dKiTo3odkMS/F9WYHY1EcbalYdw7mvU1iWBuBJoCa0tkzUXSReMleXY45As9uaaYKDyk
df0SOw3e8KE3gYPmr+AJwk/RHH12gcQ/1blpXZnQEg8DNpm9pVawzvOExI/CGPq7QoVBPnSjvMB6
KLYZCSpw6mP70mwp/Ca3gpXqMGMVL2M0eE2FjaFKtkoW1J/YE8Gcc51KvJi1Zt4lXXPPdL3plMi8
mGoz3NF2QUF5N8F5lBr/ArfSQwlRKKnKdJfZdngXgGS/i6veYBPeYbKPky/DiENnSgkjU+7OF30+
6dtGwb8BRqf9oFCmej9X5g8Sh8yDo4fFHc2S6dEojzIjoToF32R6fSjpqj6ejnC2KPOXiVC+Jp2r
b41CUlGLHO/C0GrFC2dD7uPcxvwdRojkwb0eE1AVxXZsAGXo3RQe0RPZBwEE47M6WMbWrU33mOD3
AMdEDlY2IRLpy9jdqY2wfMWRBSjb0NA2LQlBiwY3uQxEglxe1VmV2dP0ER3cHGFRjTjfN9zJxGAg
nNZriK2kj8Gul51LBlILkHcjNVsC40Myl4F5TeZrlzn0vunM8LUTwI4AbRlfzdBscvaFQfk17SWK
DcVqdpqEUodoxNlOrlLfls5ooIVRjafcao100ypB95Jk6AKLoQp3LZranyoM6PGyb38AseENLdUU
QtmcvcSN0+OCWlCsfQpqAVTWQdYT4AQBwjI2lAxZYSo8x6rczOvl2F3MWVsdm6KUL4HVWJcVPNgQ
RQbaMXKZzcvBLo9907PhlWypDKhnqJUAaW9cPTo2zQBlchTDRR3bM6Uyrns/ZVFxWbiz8Rkyg3Gj
zdLJPW1y40vJwGTpmSGyBIl1H7WVuwuZTQ4q2I96l3R2/gnFjXFtKWZzKOPe5MYsQ2ONI9t4tVIn
F5vEUOWeBJMW9CrHNRycxtptFLlpcIHwUEzsqsf0ajasGRiWkWhHR+rFnQNl2N1R80/uqAWSYwCd
cABXFTx2bW/idTJq3HJI0MYdpgmQv4jIqKCZSwqo5khnb1Y3+fxhchk4Yz3M35G3U7HiZHiytp01
qtO+TEqKEBwHJxk8NZDgHli09t4QKD/IAx/xjCiwH2jIkp9QEnOolTbDjwqQ2rRLpIaeq9cNee/M
rdj1up6jlXTBPkkAywq3ExhixiAHJgMQ4J5jtuq21vP+MHelAaZMUl1l2rBo51AvLpNYh45h8WvQ
hWcohA0wqINDtc8UGdf53HZXdYvgPC8bDjFLR+12s1kqeH/HEHLbIO9VDgjhagp11y4OsrQHxRkj
quYMuyErI7XL16Tr5peW3DjPmuYAJha8YICXQWnE3lxcV4O+CCFnksoKXnjAKCkCqKSV+tZWwmE7
CbfcBLE1IO/phV5sde7SvjoYng/zoFq+EWr4JQgV5pbagoXX2Ol7A4LYxg57aOa60eykJc2dIiAT
Z1C7N4g7WL+2UHOrqEPPG7tRszWTthO3WlvqMLPb7ks3dPJpkPNwHZKKe1HbEjlmFzjph752g/uo
w7e0ZOaqnlVlzlbqbqSAIKEqyzMLQHZ5wp0NXlOLvLLFFhkL7cWYrO7rlNscXhQaojynDhZMRn5p
jmNxNKKREwStAPJbMo5aq648tzXEnZhigDGpKFneYKj8UAR6iJy1Lw6p3ps71c2LR6VuiovItGIE
xVr+A+kGZXrjeIeBjXVL3Bp3/CpjE+Xj8ArObbrvSXLedJXbf0U+5OxRCSpPZqeBHJaV8RkiW8bb
JUPcNtAAqSsX6LDULyhcv6m5fQcvDsJHqxn3WWnOnjn1NfWvctjHWfBh0JkAFqKw57TFvO1dK9kK
xwFVbwN+ldJ6mTHZeXrOF4J+lu2zgjsMJ1LmLQWc+Q1pct1dmw8tqDyWlX2PVic1ZtZcWp7vMgOp
pUHpBDa/yNo1Bmu7OlWgrWWkaEZdACbctjcKq1b4w/w9NF4q8OnK4haiNB3phazuWc98UwuIuIlV
AtnOXeVmcaIec7Jjt6Bg0FA2I7ku+t6tsyNY7fiQN8svCrtw30SadkCKUX1WVac4OGZn3zYK0lM3
rdQHTM/ajou7dJeagUFWr5oawJdlwedDN2ctolYfAb4bxh78TcY6S6IQtg1bj7a1RG8WzGpBIucE
TUiKYaMnrthPhvO56SU2ByU8TJMe7LIyZRpj7b4z8lhBJOeAjKrG/DLFZcrm2R6DnQ5bbm+nMqJC
rjS7Xalb7r4vwleAETg27TgzPbcp+ngT50qGQEuNm49icuD+sRPYRhqSArUS6aF1wU4SjDjDM5Gq
NAUuyWSpzYw1Zb40tN52NtVA1WjVhO4RNJdxTe7agxlnjmfGFsj6ReRuUMBMpkP9uqxsbynUlZ4d
6CBwI7sLLQ+8Iv4d+NPbNgLtp6ip3IBfsg4K1NBjVUTDxi4Z07lMFtgwy5q81EsvKAR+VMV9juZE
HAu0wtd5NTyGao85iWxfcLya8Vm4SbhNzPQH+jn7Iu3KT3ZlhJ7JQo6j05T8EAT2yiPoWuWFE1B1
01RWsS9Yzj3luIn2VuOCwkSAYjnyc8sXBCCrFbexYmkXTlkHj0JCPZuZPrdLfScE7w8EEwyxytg/
1rMafXPiND1O1jgf9Tqs4SwRtRmxeAJsZ1zUrW58MLLWPRRxm28oslfQUIMxvC6GvtyDEQ6BGvZU
CrtIf1xD+zDPkoUiUt3nqrXFNeDo8KpKRMr5Y2FcJqxNCq9rCsdj+TC+ujnC183QTtHSZUADPMUc
A4rVqCSvTPDurGhc9lCKM23kYGW3dauD3a1HVr+h1kt/xnD7EbgsaLJQj41vka5qe9E34VU/V3es
GfWPSQ/Pv02CzUDa/3aaQ3U7KXr+kKSQPyX5IrtkMNy7Jmjkqwr+/jJ04x/CrdSdUcX64ywwnXuU
tmMLDXXtAnMQ4FSR2DdZqZHSHKicvJcymq6Dmi3Fpsiiepmza6+U/eQRKwM6RoGlP9SqsiOUFp9h
vMPTEmmablUzTomFKfXUievsZYw3rgaqO09l/MUUZXKgyBksaJ5nOGCj6WJ08h+c4bO/kYu6g7h7
Jakw2Y+dULdBULxmlt1tSMMYt3QYNgdDZ+RrrPgqvW/IOtUm+K0WDGhhuBRApI1naiJDqmcQFs3I
5NZ2kBmnX/O3KJinaVM6yYgpMHbjXWp1hNEIPdPeBb3ebbDrxDMX3gD6o+o5VwPnOik0VocsYijN
Tb+VdT/vq6msdwg6FjOIOpPJ1ZszleWFyuqicfWrIQpzL3Egg4dLbS+MwHGHgPnVVAdxD6t+2uGy
TvYjxoEOjrKSf3QrM6cEIudkne/9XVZ5fwSdrniJjihyBFiP+tfMj3VmY5m1ZLF3Adh7RjdUn2sB
pLyKLWdj2LMKo5Y1ZRPEI8b0ut0qPQbzfOGrDbEWXiRo1m/kiCu26fp0o0Ed9Xpy4jeJkO6t7A3z
sSm76trqmn6DnVb13I5XKqSgwnMiwpva1RmbgQj3Z8l0kyhTQ5Qqw9tUgs1zYiTk3DrYR2FUxSdn
qJZ1g1CRWFWE0zYWpJ+zIhZTE23GImtutSjs2MFyd1abbbczx3JRNyG9ZDWQfkgmvgEn5/aREhrE
c6WjuE9tp7CPHfvic952prHDoOR8qjsbXTdIfGq8LbW7aYJhvstYfABRtc0fM+cKs6dHDUxQA0TX
x35S9Y2jjuJ7CP79otRtRHIC/L4z2hGpCdG4jy3xXMJr3/SAmj3TVX6YUKz3AGGMvT4GJjHVteUW
cZv+EXB0vomyML8KTSmuplIF3V66IOAyo7jg5837IcyXS6JOXKqFRlpLVehfyzF5akCk7jAaco2j
JNrdgLYMJa9ZdBdW3P4gxeDFSq2+9MCfR7t6dr8POAt3+UKgy3RNXrQtM3ZXVXSUbNVbdsIzafCU
VKZNbSGJJUI5sp3uekl0m6qx3AxJOD2wlYLwrivxJkqicSeVId4WKg+Iqgexxb69qG5nHZWvTQWG
6ZQ3xbInsXTp7pqxUI+K6oidocTNZenYs+dqE75Vhy09UYhNHi7OYuPw9j1UbRntAgocyPjpbUaC
MD4URo0xnS2nCjK3pGINAPHGISlv32kYE/uA10p3jfpTMsJeo2aRHVIU/wjDqdv0XZV6YP60LVVK
iPJcHUR0IftD2QtUywmVwVhQEy/sx+q215sYQnhb/YjKIH7G2BdeMVHaj2XdpUfF0pfteg0wG6zA
YQ7BXZs/7aSzLI/Q+CeI2BmQ+2w2D4ZrTbcBrR5GFRA4a4Ma4iRpkMHcTZtKAtan1Gi4546Wzi8j
5aLt9fn7VBtiq6hcseWVO/vxxPVPX+Tf8ixW7kXWK7uqKcWjM+fBRcXy+6rm9BfIPZuJMQ/A3Y8z
qw4DzK2ZUCNFsaz1Ma+y8GbOwKv3Ddrm3qL+IWd5wio/i+IbWWrGg6Z3wd4kv+kY1nNDOaDVP1LT
zK6CncaxN/sG5/HwPJiCsrq24LCpsR0uKu32omOC8hCCyKuAKwXQ7LZ9KwZuWNGmOzetKovrbrQg
bwt3glWfh/3FpJFyUORmy3tRFAcNTNlGhH38rOd0U2Fbts/phwnbQH4JYpPaPsRknysB5h9HyUPT
m3d6P7mHcYoyhJVxcttSjufZ5aD7Iqr9EoyxwPIzmpdqGcl2C/bL5hLVVqJ9VzufRIlSZLbjZ0di
3QBQjWxofmUH9pxFwee0zfIfTo5HpZGg9u1R3cpR4jjG+hxtMjF+gYJsHR3KwHdpPWGk0XNn0zHP
feQ2OsRmCamgjat0V0Y49AbRxyjoFMqQFIZyKLp6x2B/mfQID4FOggSz32tg28gE5gwVRMc+Vhpt
fMlB131KFh5nJXOxw8uLbFnvxOhlrIp2MgJlkcnM+tjojX5ZFkQrsxgQoNbyQZtHBS/T10plP+qQ
UnlIzclne2RfsPHuIdNBb5BZ+ZRE4Z2Z97zJTTuwOxPjU9cin01bzsAYc5XzkHLzjL5W0R8iM6a+
0pD5p6YJTT/oGtWzjXr0etDPuyhsyHJPNXHJwYl2i+phwvlsB+Qeuc+tnG+NyLwKTO7xnSArt+mo
h/u0FNNVEKXxdgDT8oiwNb5RWZp+T2TCOZICuAqVPQa9qL1Jy+SRPou3mVl9zzqt5jjJlbsBiRJG
OiCanfOBBRkidA6AUZu9xG4GxR1IN8m8Niaroei9wHLY5gZMNePAKcRk3LJX6TwGy01OfAGHXezm
Yc6OTcv49GzVTm5wWbfXCjU9nDcUo99BTfxij8ayyGhQ0yT474Kx2f4PZWe2IzlzZOlXGfQ9BdK5
A62+IGPLiMh9zxsityKdu3OnP31/8UvdGPXcTAOCgFJlpXIh3c2OHTufatyd7MNzCK4ElI3hH8nq
hphpAzLQ4+rBadHkg2YSsTscsxcL0oeZB+ehFPZ2GLw3wvye4bctLzaP6wHsQXf2qsx7QuqXO2C0
w94bpIi6Kgn4dbqEuY77pg+qnzEdLRmRfN7wGJrNMfNKqEP1YB6cxiaI0g9I+l69JY3mGvtJ5FZY
sufWvjdsoNB1EGztWhKDS0DK0bB7Egfo5wGfyHSHgNVuzCx0DlUHRi3sKnfnBHUbQ03KtiV10MYz
ANzUg7PGllqqV5WF3nEUzHvJn9ygE+c3WvRr5Ps5TYOZHs0WOHrXZ9yjFomDbOOdx7ww7onizZ/t
nJ86v+nwFIhabcdwoAowxK0PQzOeXZfX65K2CEAzj6kGvt2BVFvZOD1QzPWWc8vbKC7Pa6Wd05g0
Z9+S1rlNFeaKeuoienHjNrHXz2ktsrhqKVJc35ziBgrm3iBqnQpAf3sXFQq336NPcn/cDlAK/ACi
JXMlGDpL92116s3ILrZEU95MC1Y/xh0aldS6X8rqJMDXxmiUQNx9YlvaMAKSelYzy0LQz87wIPK4
4zGJ+l6c+8bJgTdN/baYrG+bq02RyE+/l1MwAoNI6vFjQk2xqUGtJbl33JCmXVfrwaw6+er56Ne5
qrPbloYCQBFAcULl3HjwAy/2wpBNtBYwlRZHr2emK6y9st29herpW+o5UyK4C+q+4Wgxg6MKB3Dz
gj4PQihQJWPiWg4gs3jeuDO98EpmDbzRDMQHkHZza7pzf4/BNP+2xiFyWhMo3cAVaIDaTNzBjyxh
HuaBlCwya6j1Dt5UnrWZfvZ2clRlc6MqLwd+tpyAABH5uPHNZS8z6FKTP+P2cI10E0AT3RHRelBC
w14ywkir+lL3vWEPfrRlHW6mlZN+rR4mnRyDwChI2QxhlVBm3peF3oLXPQ1ccANInhVvcFrraat5
5gHddbd5a587kNxHvxqfGZ7eka1zspLlvu/57ddOwrZA4QK8LfV8mKb5LsUKFTW5HDdgkOq7ogib
3bzo6TFIPRRxqd/SWrQ7aXx2bf6pbXR9h7SD2INMxRc1sze6+nIX+J335Vb62KwACLIMfh5R+JHK
KNMU5POyfRnH/Klk5tUN/nPp1JDnU+pWo373C/Wb9iVOai6LpAY2w1bmWXLRG760ro06fWDEAqtP
34vOrK6E6MAsC4ZpWq2k41fZCzCtP/lkH2wP92sbLjRA3QNyQbHPvTnYBJqY/XSZzvR055IU6U2t
4RDig42LIslivw+hLy6mceNnfPnWrLdObp4UTmaOnqqI3ToLH/Vggn6S/Mws5g9LQm6HHpwyVsrd
Em306EK4j0eZEBsVVpuwQ0mas/YgC2A+A5xHNMi6jAABDHCUehLSs4R0gz47F8o8+KZ+Y6vK3M4W
ZRI13nhYUjKcpzJBfVqX67bFvGstX50zHCgkDUg5FQiC/Nvrwumoh2xEB+sORNPuwcq850qe6c9P
7srdnwxZ+5RY9kn5PySRvzZmd7TNdNMtt5QGm0IihnhhIU95PuAKRpqnr5nNWcde3cvX2qu//0Jb
hFax62z5NieDf3KWYDoGA5qfSJV9XQnCT8ldg8hnPxUo7FE362M/dAMOVdagDWs2gPrM71Jwuih7
uC5axqHucOesDbnT6TvaJzSc8BMiMAJYG2fY5lXUAZsyFS11Jy3rKusEHBWATSAcNpNkuWUaxa0w
sNunndVdzqb8CnD9wxLq1yo0+8ghvnvF2FKTaxWPzNJi32kVz5lwjlrDu00fCTU5WRAJYdtFS/DB
cX+d2L9zD/ACWzXV3qiH68WH0euUy2/qhAA4LhCN1TH+FLZxsISn4DSrK1qe+gqnV86oZSy/5qQp
jeNkrYG7Zz0mR8jWqd9t8IWVTLRLt6CQt8eINv25NYAucDLbKUemv4R42fzuoxfzT28wmmLKad9n
YnpOLq+qF5awrFyf9s0CVZulxoSzpw0RaKdE/hYssBtqvFk7WvRKUUHQ7hdP6Pu/Rmm0B4OtUuVl
YlMW7b250P4KF06MZE0zM013C8H9HWncA/xt/enL8MHDPghBkw48K4cYUVNt7aSp9ir5ktNCxzM2
G2PpeuTH4nW1YIM7ZXVdh2f842ZsTiDTe95ZYwKJ4q/ug8GIayrbXzBdVI1knPmJpahkazxyK6yU
xnR2BpZ1Y/CB0rjeqRzNuElprvSclazoVKeJH9G0jrFvylMxmiDp+VC2e6dDXpqPl+tMqOU0ml19
u8AaZFVmm0FdgcXz6ocSyrc/hD8kfe5NMIxFQiPETPw7rQCizfP6mxfE8VcugnRAqnfXs7C2EoVm
lHdBlz6Yipa7tWufoeRyAh6ym4Im365JfqhaIyHOp86uYUfl+1AML3Pf+fHq1dfMOEuOIcYk9kSw
SUJBjTrz1ZSY4UbuVs3UYky7AC06f0fqQhvzsoJkPAB14JE2vWFHXjPVW8/LwI8M1aOxFE+ma/Pz
6W9sIF8yaT8Gns+4V8NT0OfuNgNnzrap/lBW+FXK4kOE/RczRr2FotLCRV3qDReMFxt58zhqcc7N
HwtqEjKpC0gMV/V5nIsy0ungxjD1nOeFYn1r99nRIh1vUwcMNXLDVg9Alt1NOzSHSg60TpmEcirQ
xZOcsZEByupHLh1sutJ8bSdj2EBOcmK1VlXsasxpYAqAOYm6fRgzGqd0SHx6ybV7pQt8SEiR2het
jcXTv6CT6tU5QM7uYulPbWw6VnHwxunFbYz+xkxkstWBhRXVrYedXIrlsXRU8ZJNOcKwk/WPgY8U
l2XpfM3kz9saS+A9+uPk37fN+K4yZ6X+CACEUSDou6UZkmtaG+cRfqz5xE1gP/hpQ5HmL/cJwwIS
f7pgJ8RIieJl/pupJ7WH51Lzs+YsT8zZflBtPW//KlVDVaT2hk2f8dxyBZ4tWeMmBF33ZK+Ns3Xd
/KEJLhHrBNJGdCX1RltjeD97OjgJVXOSkEQVSUd+sspa7yuK5NjTM1EGFmMsHAhiz2QBhoty04NW
1dOq5IBIYU/3ZecqqsO6iMKRvL6sQfxOoeoNRn89URqcvNaXscHewqExQE4W1gifZ2iXg56bnbZ4
etcsNyA82ekbJzZU4LH/mDXZm1EzMFIJWd3duC70eNNL1ckqWufKWITYyrFagTG2IL1EH9e5CG/K
NBQogcnI0gmrc0+Z5dRnIbQkn4RUSr9Y78Xo4wIoTBbubCsnpdHNuSgTMvPK3L7FmLDcZ8q4uG/M
P/bA76uoXfvJsesSLCooeYJo9GapjFe1MBuYh7Kjm2BIP4fJo+9BLYJWPmVtzOsBPkgCrdugLxjP
pGYgLC3sOPMA5VSHvVseRjGqgzWhGaAueu5GBoE+LRk/xAk2wxXwIZ5kbDKp2EAfYszQO/KpLvr1
2LhGuylnd76b/Yvk4Mx+3CdlTSFlyJd5JBlTr314L+b5CXUBABRjdIfzPBkPepLhzaKD9CyGodol
S4mfYJ67/SSVvg/ELBSFGzlZrS2T62VY8itvkfankrAJYFCJs8wF5vzBYZLVOpdLwc2yPSBwDyZf
b8FCs2x+Z23lnCRIMGTYBCDg7FU/Se8QDTRVFgUiPhKBQ1ybydeskuLKI4z8alC9vprF6JyJk9Yu
wYB59T3zWt3ywa0TZ8rUL940kN4E+e169XrzwW+G8sMphH1c5pruNEvaVyeY7S+GZJCUdVLtciZ5
MfYu7goUU2cj9Zpdo3ymMcAicVMHXRi5tlmhIHuIqZIN2LOol2XPFAwor/RZnytAnXVjiZy3TlAx
3MB+7SrTupv4pVyJoR5OHdXNU0El/xCqvPtJJ7H6bM4TIG9W5nAZtuHHt7C4yAHrjDUrY6Mhtt4t
iGZ/HCOr9pZGbo2XpJkn8AgFwneZhPWmyYuSuBhloOQPI1jBhmMGe3W+y0FuEjYyNv5RTyBUl9bX
P7auB96RjjTPqR0/OxPQLpzQEA4X8DIXqMQeSLPzy1M/nqfUAZM4N8GDnoY+DmweeKZMVQaSF5/v
O9Te7LrrgnpXTJoW32qI242Y0DqsaTXDku1XSFpZNGceLKdedufZXrK7oU6ts9+nAC+k32xzZ9jl
Zs7IDjE02Cu+T7w5kAOjXC3B5+h41cHqEa7lOF7iBipwLwjUQnx43tJS7tXN+puUeEOZFjIsTev0
cwJqeGWatv/kqzKH8+w7gGOARDOv4eBlII3GhxrggYDNnRAZsAnUn5wn18rr/ib3+WVii3OCT4DH
1T1D0fpTSG/+04RTEOV5gsAGYuVu6HwOerWk4B6d4kEOlb/xR5uxX5LMxzDj1Su7hkmOZee7yqHM
Bem4nkunZwNnhUTs2d1V6TlYJ5bCU68gUB8gAH1lqZ/2F+WmPBhCATBRHfGsoZMAaiu2My73bQJg
FFXJYG+gmQM23UFwMxd7KVpuzrBweErM5LEM8/ZZd2vKmgaqRrOt+sr7BiyJtGTw2dMZdEAoOIfz
Yuh2wiqsc+0O0GFmxkF+eWGWoXZ/mkaY3rT+xJgJhHDM2BcGo33BG6vu3Rg6BdebDoUzMdPur1OV
E+tt6Cx5PmU4saR/P1vUaOmcDgWEc7ncNdjydmMvsse+b7EISAOzQMhH06xx1F+M27t+qfTOnvhy
jDFtrlr2VTdZ4IqtUShadb+xT3WQZJ9g89QOSsNr2tRg8jgJjJhQMFdulFWrDz/1YEzyM9n67sLt
wH4xwWpYgNYJW00kjbrYq6z/nIsuZRTafcjAX/bsTvd3hZr7mBJcHATJlTel49kvfjH0B0euFVM4
G2lqaan0ezhm3dJZO7NJhq0/lTg93HKOK93iVkuBDyqLYlY164dwV2+/mnOyY4oT0DoH/tbPV3tT
51aBG/+CggOPsgsDg3nxHA7XUGU9BibMhtKECGZrtodIMbj5aRP8dXMJl3LE+BOBE3f5twGU22RB
6DLT4jr1AW3CBYXFJmyHh1LW7sbrwxcXCixZe0yH3jO7626bJfj2BrM7iznlUOhrk5tFlM+c+dMW
5kQ0Dk8mIVCPztoiFXSNfZWMfhk5mV+cVjQyOFlMzYd6MmKEnj9V5VUEUQ3VeZ5zRXmbk8k5z8Pj
jD+Tubo7v7hLkjPgNJlvEBHOQjLkY/S0pr/Wolg3ViLoBBNefa8khk+QTHXrOt07j79/pdt12dCx
VYel6s33Ikim45rNjJN9vEv9kJrPeWfg5CzaB8qxNl5nUfHzy4zb2e2hu/qBv8GhZtH4lQVjRsyw
MhkkQG6Hvjrt+fZzLJ2doz/GdAYROXk2r0VXb/2sabZDAMGybdvwBtN/vht8qmmD6TZI9vIHKG2w
n0JEqywzq4NtTrgivLE/eVxDDZO2WZymZs7P7eKIBylW52pplmQP9PgtSQaxX7LCOC/ZKD4TkCzE
KQzrufAn9wru7rx3TJldFV3T7dtmSh+KBV0ASqZr3EhgfrEz2dP3UOVrw/fmPIaLUOQNTxp/TSbb
vZ9oxvjd9B3YIyZiuv27tMzXlslyACA49QE/u0ykFLjLo4PZp91UACw/iyZZ+BWO9BFlGH4Xo1Wf
yt7x7sjpxJhfGG9jupbnQTGWFI4A1psgOBn+NBzBusx7VL/1RufGuEkhv8aDHvSbnWYgoSvfjm1n
7R+rLuye1Fx1u7mznSsiOcVm5m54B/i9w/EWTV0zIZ1kQJJxWRjm+ICQjgze2w7I807dJotVbKXw
RBox0OZzN00XD1XGcWiJWwZAPynzuq0zyWnXZgoncHXFIHwzB2sWObqvj60mACmbzelpKle1NaZV
PkmNacxPxfgdoFEhuunuqNbWhYKS8MdUMoGghmgid3Fe+Kf90eXOPZDs/J3houTnCSLTS2T5qcnF
e56dYthxMCTnDsLOqcb+SeCEHW49zdrDahXDp4Wv4sNw+gCEetUngJ/Ml5Hvas9P13lI0qZ7BMGn
sqjtRrlVjVabZOk36WKo7VpXycmaiBoTg1gfWZRcyZBzwCWtZX3fWS1WqKLFEy9UkN+m4O8OxKFR
e3fWeMS4sDxoVzWbfFmHDfi98Bq2s/dKq0yHmTl29W0sGSt3SUsf1OY+0vYohnMO3+2WDvrZt6t1
T5iqS3xwOoLSsebnVtPXCqVVPNnB5yRdcerIw8YFg7DM4LFgFIkrkm3DBzJ0Pty8+Q6SNEcKkOir
hDUgW3jt/McUmtFPUY0rh2o9bOhVaw58egzS+swv4Sf2vmrc/Mppw5bVNkaGSSTS1Fax7MXSEQPP
/1yWjXFY3bQ4BLbn3xhZ/WHMKx5QTUbdwQtlc64kYBisjeuV3/Y5k+W2Zv7q3gPPkndW0jDh8mV3
D0x0eZI+IXUt0zpW7piYZ1Ux74vc+CiXII9xYrkHt2V0UlyyI/ekJqanMnCzDUNR+EEphwOho5O6
wb/8vBpus++ctrwCc1/FU61Z5Nbuu4t15SSryX5zL2y1PJuyXbgkL165fEnC+zZFVTlbDBEsAzY8
Ul1iJw9NERxM92bWGC482X4YXiVvVNDVD27ncVEGEFPHX0tLg73BDNiah+s9ZXYReaVxq6GiouTb
Xy0Hcszt/icPvN3g7lN1b9r9cCOGpr/x2E7UI7TuxMedGKRZeG2W61dvWfXGaifE3j4PuLvGmtsW
3a6sfFqcurKD71CRxBYNPm6qTDvedrVNiO5SkcuHTrEdXEygfYgbj02rt6lvypjqn9AdM/GNDaZf
79HjCLwVfZHdKRwQ77ls9B+xNvWTMDFi+MNoPWDsKDiIxhq93fAjI53yV9foWfvE96cpj411g+ke
l6YhDslotEfYvSO7pK4o74dywUuEZqsY+yW++goF+7HYddptiwnrYDGCxactCctuHNDLorRifLBc
HzMA6pXdVEZcRnuXIc1dLaGQh7VJeJwzSHHkglNSAiRI+rk6leUsFkZdsBSnNJ0fR4x3e8xe3Fhz
mWxDXIlPymzKDVX9emiTPI0ttPZzJs00xjaB4jPR4HjMU6K/QmoTA1kihXWPRGt/BUOC0OZbBjJi
oY3wdl4oxOc0D/chZrsfxYyVdlxjdBJTse0nWb8oz2nwH3ZoIfFohvnGhVG+Z4vADE5ZUDC+K+kt
YNn3ACBYuAQ1G3juvfQvOOULko5u4k+PjH8zOrnMN6k3BX98gNZRN+LbSZiI7pNKezcmmzjUU7J+
nOE+kn8fokoO+foV4kw9NgbrhG2BfDi5rOPAiM6fJ4xTCFLTfBq6FiNEEl6YYB0BWxZwIL4RHMDG
GnbXPc5VpPgcu0Fa+g++WWEpMcDZ5gtuPioVc98K9Yb4mO1RT/mkKRZynU0/ZIpUX1Cchxt68OS5
QteClKubY6OLhftM0pS0PKCd9NYDHZGILbvqjuFYy81IY/SipQbf0E8D95BFmGbmpUevKfrj1M0s
A/g5Xo5FuNM+KKr0pk7q8HOaUPU6r0/A8y7dISuoZpqpWYBXMOE46nkSB1Y2JopXj3ompEXLVjyU
S5HqHHk4UO+d6+jtwlkYeblczr5kUZGKyMsOLuUDwASmm7YlcRpl7vA7CANioNM3zRtydfWw9Ng+
GmkkJ0X80da3mfVqK5WPQz3O52XETEmoKDszFT2JPUwhM7DSe/Ct7DEzVbI365x5XGW9Y6QBmVpw
GQZ2lxxwzDb7ek6sq6H1cXA5qZ1HAJWdRzsN1HnFMcez3xWx4j1C23FDXnUmWvAQUfKNxYtmIoRf
ecnzm8TBfEqTXL0MIYkDkZi9Ff0m6LNtONrzLbjY9CPl78HDT3TFOZdn0ybEeKxyPFpVkG97IoK3
bZi2G7In07h0UTVSktlItOLMRa9/dLG2b8jPZI6YSvXVg8ygH8jnQ4pxO7aMdTxNlmZ7Xc7FVR0G
/U7qcPnjuwnvQsgNuuf6aeOGq5zh6gxNw+gndlL6/EInbybO5V6WSDXp+toHrL6jD39rcxy3k42z
0rTTNYvJbTcOjqcgKivGlhiMthh3QCJgSpnZEYG/gU7Kioevlp/Z1W2UFow/Rx9oXz7LbK94A2/M
XLNtNJrDGyPjctsUbIRqmtUrcw28Y9kGOU6CpP4oivJ9skyEzowzxPFZ6kia9d0wGs1qjOPiDe+N
uMXP+1CwwcAKfcmrvLq+W+AeAVbjpcC4O0cF/9g1/V/B056aiv/8++XffDftyjJSNvzHv//Ln/a/
zc1n9dv/zw/6l3/T/8dff53+NhdU2b/8YVujQq33oErWh99+LP/x+f/5kf+/f/l/fv/6LE9r+/v3
f8PAXA+Xz5bKpv6/8WfiAl/5bzLT/wNNeyyb6beW7M3+47Nd/fz93/76J/8kpnl/cwPHQctABAE1
arGE+1+w5r/ZvovZnUYuhEF+2aH9L2Ka97fA9zw/cPgvCsMLFuafxDTH/ZuDTc3yhe1BMLWE+7+h
NVs4sP9lFc8HL2YCQhW+bQFcEL7zP/ZTCWnzOTNdILJYaF7sZAy+CCvEDcssmTS4EHrsTPjEtAZb
BtB4VUqOzgZZ3rFn8oLq+RsYSykjl4ySA1xkjKjMPsSN6axVz7XipN99WjNeM3xt3LRWNjHPLxOU
0LHtuaICTEWgPSxJN+9cFuoquowjVl4M28LeUxn2Yl/jhnlOg8Fqtq3TDNluroDhRkyvkk/RsqtI
q2Ez9mq1cxkK6WlpNhrZj2aeK4ZVPIUJPepLjreoWDD4E4WRFLf0jYQF9a7dXyy/SY3aXNt86WjQ
3sZyWRYJOXzKo9243QllvoKrpObwowN5onHY5LKOp6YM9RVzhLRG5zLXnw6w64jXtLc+c5I2rnN6
wLMqGTD7VsMYb5jGbuF8qytWuXSGnN1ZluFv23VMjZNtCIKfmTdUHY2n2wvuh3p4y4Ha4X8U3pQe
VIi0s1E6X96EdtQDVh3SLhRbWkzb1mJ6S9B6KrinYfdWpa7z7lup+0KM2vxRqJCmy5PE01ssRaEh
dnZm7Fr2aWtGi/mN3bJGM419JBosRKzNYdCOhjYMMNw0wUuY9qcmyyPb4CCrLcmCmMkapXHrJ2/V
ctc55SlBG03WdHNx0vBV1BdDCrpqn3eSwmizSsGqxvIZZPW9aZ0bdllw87/SJ3gH0eiBllNuQoJA
hGvEDMb9rcnVrg3xHCSSDZlqjFtL3bprxXhovLZcvEKVvl3G8clMQoZw1kvZ/+btfKfSl9KTv47C
xpuabxJ7XjUhGOjgdhwwwDIei2RyZVFWxLNj75Osf1MFmxb4eNS8Utere16/CI9Az3ZdvVeMKdhn
387+sVkKjEbjEtWG3Duzi9EgQTgv2rMOqm4v7GKT+9V5MIMIZ++jOQRXeQIRPUoHXLEuVk+v1M13
Tmy/vfAIBlR4G/i6WFEa23pKJr/c1I61nWbTfyxcFhsx52TgxIzAdbYMjY03z/E5+NX4RxTdtRfk
pN4H7amGvB1Pcz8/9WtA01PsxmQ8ZunU3fis9jipjwFUXQ3huRPEzDnjHcL7TuIK1074Glqf5npD
aRIX4cZy2ng2Xz2LVdxkfS0R5Ig6OjgYXwWQIsHYD0QAuyuaDn549Kr+sukShWxz5yamT/3hOdM9
LR0t7czEFm86iq1CYDMqHGX5Tem5uyBUscn+Ju7emMNyg7q7Kwa1k4F34mrbLfPAMnh+StnY0HBF
Ve6eGV1uwh6DolkfXLsYtw5fi9N2h2ZgSmk8Z+W3GJOTjTKSrm+CcWYUqm8amZhxsEzKHa9sHC74
ztLvzPP5sjKUgcFg9aWf3jOnikjciP3scQ6tJ7VgOMic8Mswwk+euhN7pLwc2RS5SjC1ZhMzdHAR
deoiXk+kpS8i6iubaU97Xy3+LvGwlyhvtiO3fvOG4Tw5RRQwQafgQmUeWmYlXruhd9w7zKU2pKaR
9lIfPJYLstqKxxzLaDL/YiBhf8IZhbiXnYs+bq/M68jRk06wTebyvFTqcHmmg3JO9glo+A1PabWz
pFuclnJcHhb+b2Y1vfsGzrMgn67X3LuxdfEqPBeXsM28nFSiviBMRwePlV7jqZ93jCkjrW9NKY8h
3EtMC3Hj8CQDgLwxMV6ykxj17FBGgMgZRdswq2vkqzXcKd87svvukXDKW9y/2ZP1oarl4NdV/ljP
au+s4cap7HsGi7dmdXaleU6LYN9O5dPS+Dc+zic3KtbLFLdV3SNr3A/CmK+cYNha/Z1BNx/L9AHb
6blTBRgVSvKaaWY/do+lr68n409gh8+r3T0IlNS5202d/4xNmrKYNTkm8WLYL3NhR+BDl1OqyeTh
MDY4l61c3upcnXVunkt3PTg415q5363qPmsXekrjjJ9pG5Y3pThUNqOSLLhMpCsZ93V1yR5gspCL
CMetv22w75DBOoesF4M7E2StAvq025WjpqyGWOf2Dhvhn35xr/KgOMjZT051HXafleuxPEL96bfq
lmua1ABDF8xKJ9bHqzDKFDjUSCONUCmi3/bzfskBCLCqMJTO3pUYW8VGD7dycM998t2V5tmaQbbX
zW6A6FYU3AD5soUHF8tM7HUxfinpns3Vu8OUGQlb7xy0bRYNOY+/tLhiEf3WZ7nPQH3p78zqIvid
nGCKPLtHQcgOYVOxg+kZTvZp68G+JEd1TTwW/W2RLBhxu9hHTP+UIKW71fhy8vZPJa3TuLKfYTOW
XD3K1AHm/YB73Fq6nc9+x1xvid1+mlG4XyGmp1iFzgZ+EFm0t9VIPiWnZvU8du57oEFiK+9bITrk
5vClu3E39wbrzGsij67jRIFAdEHJZ1HZ2dllmEZJ17xlBhOxXpp3rA55mC2AZLCRF0a9mfNyYWDB
EN1yg632crArzSkoP4kV/hSJw2+ZVf1AXIthOSgOc8tq6Kc9R7EIeiYTig5zDg+pb6JOhrFryrfO
8PklFecUVsS9gUXYWF9Mc6BiX/zQvdEw7yNTuTAjh8v6F7s4znKoA5e3k/p90uVhtd/6JA1OnV6u
vNnFgNT9YQHmTCtfbBYE5MGRsbvOh+ZyrRZ3TRncWt2rgyDCwfSsF3FCOop0sIb3Q3IXpP7rkhdX
Kgx3VVJGy/IVWBJ/VLOcFFTv3B0Z1dGj2PKYh+lTzjJ6JJaJgUm+u6xXxeNlB33Fx9Dl5itb5t8V
kXWTuR66rr8Z2UjFWrzDvHxVrAGPse3u7HD8ST0viF1XXvfBeGyG9C5vCTKNnKLfzKv15KUIcV42
2VezpIetVMhip3tmDH1l+6deunuOj9hiZ/865/tjN4qZxH60JpOgTq597FPS2ur8p0lKGkGKOmZL
sZNXnLvLZ0U2RDnxTa6PZZ7uFAZ1VXzYedBsgvq9TUU0hetD4KnYXj9sZg1SwwDU073sc+agDWkf
7y5O60tqV75ctDqqwexcDlwHXh2bwcFzrR/UtoPgkMfzei4bKtsq3cg857Zz2UEFnd7bO2RRUjWt
LQtczGqXu5AApgGrkI3ncQg87ubmYoCKcvmu29cs71esb7K6lYbFPSUQW51dyhJXUTSopSwvaaO5
mauR3cjJYT7BrsUxQDQkC65PD1Koq1ywIDfxja4nxmdv7MQ8zshwr27LnZzlByoToK9WlAiEI8/Y
Znrdpsn3iBdlU5FF0aY/k3A2mkWHjmLSJLPocsEuNussfCELOIUaf5npeTyiTH1XQj7ojfCips4u
6O5ZAOruZc5yOtJ+pDQy79xSRg2Ijm0hXib1azjsmza3k3mq2mEbJvWGbfNozp1d+Z/sncdy3FiX
rV+lo8cXFTgOZtCT9Mykp0RKmiAoiYT3Hk9/v5T+6C6ydaWoHvXgTlQVVSKRCXNw9t5rfav66k3T
1oku3eF5Krezf+7LGW4x0KVMp4qXwAwXaX7TogdGN31q7Sz8JNgG382jWl76rtrUGaZUk+BZXzKz
Cstwq868t7QnpRVbKkPn7NOZJYDZ4TZOxhWRU91jPNb1hbEJlJfg6PnNq2i29YY43JKeGv4ddJwL
O7e0PowMZPPJQudQRPsyMc9uuzcMWGIgMdO89kf3OxRZTIr2B0Obz1+qokYR2/FSzhBPux2tgYLC
CFrx11j4a+zk37t+GO9QnPKS5X3CVHsOg6N2XzQy/RrRJm0tKParfDglXnQ1C3OI5x7Y1dTDazjF
lnyBT0HH2cJnge8rYJdT+BQKtuT55cEIguUg9YJsrt7W+BzOWxmJ56B1ll0fyd1YJx/iifNvcvS4
X8dsOqC1uUqiZu9W/r7NzH5oXkK72BqkEk7wLYjGm06Nu1DB6sgw7vZo+MriFLrZDmXqKolIex3u
W/eQ5/d8VoJ/rWSdR+bR4SXSZ+6dRCwre7EuZQHsj6mm5x50CDR9gBNG6SDnD03rXA2hfemxDl6j
SdsbRW05NvAhy3WSM8z0VEKQkVIk0ll3sxM900de1SivNtgaUongLu7WjRJw0sGIL4H1oFCsVC4A
w8l8mZg7H8LEPUx1FVykDnIBtVg3mNzYyWALEcknmpWZN4Dks9cIqMEHWExQTdY8qwJxtuvdFuhs
8/QokuY2CGx3Oywu/uwsDwFRZM3GC4srYu1XWHjoFDvzjr/4ekYFEtnESxhSAk2zKLXxWT3OBWsj
Yj6FALWtk6sQqoqaGN/hFNwPkY22WrqopPvxS4Tg6IMsmsPCzi+nAA7t5zRNeLpVZm8biXUJ3ynW
P1rwPMA5pcUM+QyHCnULEr1jJqn1KFwuJeAUdEHxITZ9e/BNO6wakz3kxJXWW8fiufQoRdd6Ehu4
YLjPzq8E25+/uylJEzT0miO66Q4RQK/WWVhaL5bvNVs83JfE+X6rwcpgrmfUY017f1TR1vGieVPX
4SnBgQ0YzcIbjFMK6V49XVpevXUbYpWGfieccVj1kzqZxYZu72/S1rvqdfNU0HnP0wJuAbRLmNyo
/UM0xn77jDFrj2TJ2jCTltsRmticrNUI963Nl4skVMN9rRJ6lXIzxSN2jkNW5cjwkQHgYQn0sGI4
vIZSdQ9vwbmIq7uq3aN7dBD2omYvL5y5f0Wqdr5+/W7xKn5JomM2JrJJ5gUVpzM9Rr4ftGscNu3n
uGYMjMIs6F4DEtLkYWYETy/Tt5tg5wsDnSRJl97byKDC7WVNPeFN/eLzQ/NYzmyRxaxv+jKnVMpk
l3MOCihIQGCW4LrQtt2wYIjpqptRIK4s5jbHKvRCuc7ZkjLAhuxxCBnu23unBH267uq6uiHcqbI2
5ZKJy6Coecd0PLzxahSisraTmN1b3/fY9eukt5lc9p38kgikGxdtp/yG6kDpc5O+pO5RiB3u2A9R
4s7LQFWZ+kv0Kcljfp8Xlss2dSq/ufw/cOUZBKXwntA4N8u2QJu2bPMffwJuqpftjz7dP2pVXsXf
mrItX7v3jcg33cqb6qV46JqXl+7quXr/N/8Xtiz17zuWTfxvl89F+qZlef6Rnx1LT9B8pB2Ijdkx
WvoO8K6fHUvX/4shp0dnQTu2T/PyPxuW/l8UGp7xpe/xU7Y5Y+//1bA0f/nSVsxkpLG5WWkx/pOG
5ZkJ+l/IOJfEPcWnIlPDkQx75Xt6fFUEjgyGftqKZjB3vjPVp84RmEjaJB//gHd71xn9eSyPBqxt
aw8+xfn//w0KGE+QnGO3mLZumkWbmJ3A1VJV+SEYqvA2TdgZ/a1vzA575tX2b0Wf35Zx0bX/8e+/
+m6uYzzhAtzXAB/fHs+dcFkUbjWhxmvxL4w0IohBzzcaGvAfDvUW2/jzNLquQ/uKibmv5buvppmB
t6guxq32A/9WWG3ztQ/m/oM7SgEXLQuCq4Z9MHbXpGndn88dTwz99198z18d3DNstzi0VNKcz8Pf
zusEZIANrDUBGiiKg3JpsdKVs4sbyH/llW2o7dEu0DHLguTb70/xW6Tdz+/ta2EbvgZ91PNN//dD
y1Aoy7hywnidgHtx8vSgKtT1vz/Ku4jFH4cR0rV92zjcO5oe/ZvDYAahaYCkEurPlB7LoesvvRHK
Q5XX8qFqaNikncd+HnYU2NiW/V+ddyQsk4IzrH7/WX7xjYVkjkDwrG/wDr5jLQad7pIpt6dtbTGq
t+hcAGgqyz+gAn/8mnfPpVA2D79QlFHKf3eYUJZTnHhcU+mN+KLyszJxYSyA8lxb8xftQxXEn9EW
+JIXp3HoF3jhB3zinfjDyX9LVv157jWfg1XHYzny39ELdYjjKYZ9wnyxdQ7ekIePau7nEzq55DUe
mbYxnfDv//lZ1i4LksclP09s3l5wzwOBVS3ZvLUD2inMM1/gif0pMfBXl5ILqMx5XvTfD+IzjU29
zGAOqmLGGGf3B+vR/+CGkRgmWf1t1lcW+rdfpel1FSGr54ZRfnTqc6hsHSK5f5To9eMqASpwlZE+
T6LnvUPTSmcMnAEX7XZCr7FpPYT2jcz9P6zgv7gXlJQscp6rGMD5757Dxs0Go0UwbrvWU1shQrZM
RR+XH2dHnRGOnbV3XIy9v78Zzr/13bOgpOsaASFRsNa8+27Q87ohblrO4DjnsAaKEqYOa46dp+oP
6/g7pvGP88idoIXHQ8e1ep8rltUVA/YWkyfWbQ2HrkDez/heJ9gaGxs6OQOiYj+JIY1JJhjomcFd
SV5EW7U3jJ4CIARpHWJUL8Ufo9d/cR4YZQifMbTDDfX+oVgQycahVN2WSlkc2WxS7JU92jktoz9c
6F+sP1xIzRvN17ZhGXp3pbsBFV85gcoHq7K2VLXn/fIhtoajsMNLM2ISMYm7zStgOhbWmd9f8P/2
YDoc2udtwgqrbPU+M3noAzELlERMhky4XiQGkdLT4R9uq/M7+c1t5Qgc9GyuXKU0M+V3DyaetsYl
9woSnqWSdVnV86qxYQBmSzjulWdtf/+l5Hky/e6AvL18zuaZ3cLG7d1+BAJMqzqcX9t81lFOslnW
M6xhT0Hxx5sTKIzGlYkJJMue53TK4o3IXGpE1OaIop3RjtQqbLkbgcPYc3iUaO7kaqqd/jLLhawO
fjeU31ooSWKD8rCId1lWJN4KCyjQpsZIwLqdCfozdGCgrxrHZ1OwWwbMHYMCH9heYwcBdGUqMvVU
yCQBaTTgVdfL7Uc38SBcZczlPuV9JiQF2zk4oM9phO2ou9i+QZHrBb1Nr5Ufm8YC7Ianw0s2blGe
+xeDTKLbIq3K+bQUpePd1pMTKLpNMENWo06ib6KagVR6MwwK6re5PBSIeTHETxh+20kkD8iUwSZK
gdtjNVqunz8UQwJ5BTCLVF/a7IxBqyw3Sza1N7BOVF6NxEXjIWbq2jqMlHszZjdeE6fE7JZpdVvY
WM7XXu/Uz1lw5mrZ7DbtdUUb4qGMavzKgXGT56BrmWQCPJpf2jA/N0Jo0b0EAkXmtmfltQ9WqKPo
IvCxAicwz0f4iH1ptpaCzAhT2aT+KvVSupxpv9T6WvZLWJ5qRuXlpXErMA9AJIFYcIlrS2XXZdiA
yOphrqhV5w8SS7aXwIjF7RRgdjeVUBSPZZ9eDFbQ2hcysIovjuoWJHmYoNN1VTT+V5xzIroQFQGk
23LJYwzFgd0dNTqIa6km96nrKma4jXGDZGun3C33g18PydFFHHWHH94RGzR7bKjUVNCR8Vp2Iisw
lqj8UtFhWSJeux92WCAYKJZe6D8jDeyzfQNZq1pZmdeMqwH4BM7ctIalQZ54362LTgRXuhjm4ATD
zfbXBI1bx5qTjGqIjiQoLGAA5UkxSw43krWn30w06G5TtKzNEVOIqVaKs/lhzpapPHpF381bRm9N
dyKyur/JtSE5GoNpjNjXtaqnFDkvJKYsxPRdhJO8ifHuXk5ZTdKzFfXFKxuB+YkVLyr2sYnaz+Fc
MKmnQ0X7HE3u2emAEDLcN0ioILpGZfyNzDkamWkxd88a0CBgmPMOexXQsXnNWAYAhWVV9hA7E79j
qupEAuMGbQdjgImsgZnhgB2xLLWuPe+sIcf76GyxnLvT7TItS06jRpYi2nSq1zvfYEpfV0gYOu4I
kLs0Ib3WIhBxYAqBuriUWAi0nUHXoXXHjczKMNLnzGrrupuzqv/mhnWUf2wnH/ST7/TVx4oGxfQp
Cov2bgLWQHoJS6GH3k7RYoGltQTYOrnTeQLhOCFDgLIPv8rYF6rvDYknEkH+JdTY4EnBbIPlFyaZ
t6ttPT38WD3/f2/h38U5m/b/LYe6epnib+XfxVA/fuBna8HynL9cKRRTHY/KDyHTf/YWLCG8n3oo
6nvhmR8thH/JoZT8i2JR2y6bKg+XpM0n+Fd3Qei/DK9Dh90+pYdm2/VPugtvK1Nju0oqxUvP4YUu
qR/OL/q/VaYNE+q4wJB0FY3YwOHcyFncpPhR5DcLdBPjIguR16lzEafsgqxJlse/natflMbvKkc+
Ad9baUpz3vA+Cq/zJuBvnyAe4yxKWeMuy7au5UYOjeM/IMAkhWI2flRBy6eiJtm7mVo4eAlGtmOW
K9gw61A0Icu40+YBRPI/fC71Zi/A5/KggBqqG9o7v/hcdHjYw400AyVO2XZDhk8crpvYw96Y4uca
ABsujXPdTgo4OLROiD8exgLkzaiTk9t6TlOcLjqCFWTKlrfuHz7f270mnSVSO4yUgjYUXQ1ulrfn
LVWZlpUy1WXsxEu/QWOt5pOqLO/Wmuy8esVBQftZEIDU7s7ws5HMadTNX4Hj9M0m9E1zT3yuN5xC
GqgLE47Bj2/BKMXm9g+f9LxN+69tnOEN63s2bSxF4ePw57srjARMaGzP4rTYUzZdoFhgqkA4B7PF
sJ461lwnL14QZPV3adrgq0rGujWHWk9d/IfEmvOh3nwUBfwdWRD6Qm48/uXtSSviCMuwI8YTUIsB
t5vI2+xqHBnOrlACJKSTOnUXhX+4Vudt47ujUo05js0unYL5R5ru327xYiktp0hm3ny2MAOAn4ZN
JEIH217nHVaWD4thhkwChI6nfSmBYMNFQh38h5L93R1DHe0b7XtcAh4zbd7fMXnB+7xFhXKyp0Ty
Modr0V/oPJngj1QlnpLfX/e3NQKXXXHZjTjXQ1IL+hJvz7Waq4wJeQUyqSlTVOt9VeqaiZ9fRNP+
94d6u2/nGKyHPAMIS7mw56Xx7aFQVDteqOV0xNUy95vq5ykUkaNOuQtX82MDkW65mLvS6MM/PLTW
2vVoG3Bl+Rjv27OWozM49G19dCyRTHvPyREq4ZZ2bsp44YtayRw02xrtcfOHu+r95US64bi8ARz0
SMKhoHj7pS0KjLZh3HZsw1rY67oDTo8j9bwcRc7InfT7LypofL+7j3mHCUF1i+iSUQzt8rdHhHuH
vduqhj0D1bnchlY7v3YKnPWBSbJmgF8FZbFO/HxZN37ibJNs0Kc8cwOzDSjebpRL9NqQkgEwVzPc
11o7qzwuvRPpDoylZDGumw4xfdV0TOIQOjzV/pljb1vO/egDJkEYita2764nE0QPQ+COlYbRG9Q+
Orl4ilN9tK2FJsfLkDHeaxvEgmx9mq9V3w670BJQlRh0XnM7fM37ytobO+2uxFRBVDZ2w5A7EIcM
QSOCP+BZp4Yd9N7DsPrBmox3E5d+gRUfC8BUlS6G3iq/bKay3sSWTSpBcvZphpZEEyHij8oRzX3k
wglgmpruyt4kR6coCfgI8o9jlS53A5YaHHUl3EbIEvvOp3sXwsh8rvruFZcKxGyMeChyRwhBwQiy
O3e6dO/7JM7XphmAJJpzqFOkK/jmnAkBNxTDXSUOnWIIPBJZ8RiIM/uFpElv1VBwPDdpL/cBsvhd
YYLyQ1i33haOQbHh9Sy+eqPEZjjXoGnnMpyvtElv2Ta6d8br2Ls6nbjzUCbfD6U9vA6JmdZeYvzi
6LvKQ7dmxgKurdArl09CsDmWvBZYFMxVxtie+mICEZZrJi31pWSMd8Qev6wNO9S9QR64753qIcnh
KZeRQxSOrhlFgnvGo8pfI3AMuqJjAR0+ybBdLpMk7z9AuY0+J3R5gg3LQ3KTMvJ7EF6gbhDvDI+5
FkBQo8Hf1n1qQfnRkKpiqjjcKfrMR4Jrsh/qOtqC5EbcAJxaOxsfuM23dDInKdqsdTZ0X3Ai7XDR
JSZ/qEOLm+t60pNBwRPM34yozHpyWkGazdxeAOiaToOv3U/DaMXTKmogHUYWDvFVh/noAG3qUYZ2
9l3NRlxUHhK25CxvgOw3XKPiigkkSXa2myJRsOurHipvyEU1xcdZL/EGXz7ab425I5PIg3NTpaAU
3JThbTusm3FerjQwog1r8rAVktbMqjLRg9uIywSu0Xp2y+/QLgPUJyF155w/CBNBKYLwk3oJCPMG
lfssJvsz4KL9YJAbdbAiL+cQ6JCO+5ugHMY9wuVpq7I0Acs1DchhUyDCVoBKZ9TeuBsYsKzHIVmu
x87191Im1UHmVXlbKFy0DlwLnMBxeAvbeL5k/lxvm3rqT1blWMB68BGr9TI2PYUdvbZmXclhCKH5
5QFJMxRKwzqIounlDLI2aypsRCaCYG4RdUmKiHbMsk/Ugpn1OR7mPOCXeDCj0Tog2LnC+FIk30WQ
iNeaKycfcVI198UMtWUzFojwrj208M6T7zZx8NhUvM5zdFBxEh8HB6bnK2jbAW2YnFvnwWGf8b3x
MqTrpKaDhRq0F057GXvYs1UIch6//XljVlhODy/G8boBKzWK22DVzglk19FOQQxa04h6zWuHJt4B
zMU9llKH9pu272H2+0lJsAcALqDK5ZzzGwZlEflgzTGcNhFStYO47b3LEOe6JtW0iNOjmTkFCPTT
CdbkJDI9XLusxFpjxvXA3a1Ew7ry2EcpCto8YLizAlztLzBu87DdatZRh9ZpOepLxJAmvQJHVi+3
2kaETjDEuAQvy8zzcZVXqX6WDRvHY4VA9WPhc4uF60Q0bI/JieCt5NZxYD5NteDcYCcCyogLoTsu
soQLv1GBA1sKJ4OiownQeV6A1e6U6NzhPs/rMD32Ed4/uByT55wT88psK5Q/wnXi7hxICBq9yoPO
XpHYwiOtl+KlWLIo39SMU8uThOwRXdg+Q0ykNpYXjwh0qcxJmHKL2G+aXeyCo3K6Uapd0dbqHmkE
1/uytgErgYLK6prZGWTgLA1Pps/pvK/rcRpYu1jl7bU3q9Hm4vYFKZSaKRwdCrscCJKIBk/RzvDs
BAZfnaao3ZZoaYnWECkkVj9HtoRhE3EBuI9p6GYL0gJOrD1YfAJwYjgbyUajn0bj46gRvLyKPNpR
mUjDoz8xVn30J29sXvJi5LJYnl0N56DMKOFtOfLHtNccHPVIWMLSBQxTpD15GyNM0FVd0oo4v57I
K3jRYF4qlAsLaEe1SaiKwld2H011hzbzzEM4q23uw4AFc10UbNsPZVSF8ceqk61zPbQzDtl1JGoV
fC6auWDJCvo8Du5rKWwCKFqnzujWjxRVONWzOaoZTbFtaVBOZ8VQk5MU6LrsNmU7S3aJMxKu5INV
+9GTGyYCWDRa2gzt/LCf2rS+CJsMMUlfB/q6U2b6Ysg3/CjmwT+SXeCsYZxXGy8TziPb8qe6DeML
vl6xGwtqoBWJQBCasvTkaGTkO3wkc7Cq8rJDhjg91wO84aw5uz+9xLuyOnTTI/5W9gRVe+FMiKVg
aBT7ReI+LCfdrJEPANOOJ/uuYl1Bqe+7N5C4yOOJocaJMys1qlHWNUyhDB4Tt4ffTc5Aahn/CHq7
32L2W9Sa6ON+7aFh3yyD3WX3xgthIFtLT0Yqpei0qf0kO0ael+HcxAEPRyfMUhTKmu7iMgSHOAdh
rsQQbdEGgO+IxkcBsd1dOdhYMPo59cqm8XYapmY+6sTUJ5mP44prkp2GgrvadJzrqKL1C7uuMl9l
WGV7lRA9m039WS2ETborvPquJF8dlVk5XzRL3G6LNnnRdNXu69DgIhTg0Msl6JEzl9F9mfDrWgLQ
P5qsFyRMaq+6bLAmK/hZcFqSEcGvKRSThN5exJrMBTDGgG2Gj8tYNfk27sqJd96gwLwpNx5QcnWj
ePUDCyz/rNWjJNKWdLwCl0NbWTWwejuJz6EDhAJTW8FTAMFpHlMhZ7Nz8V56n3Xjh8n1MM5n+g6L
L1UnRhK2gCDtN4Xx6NtXsJXYDMkei9bC9qAGadRXDzEv62MYxvKrCsvglCqSiElWKSE4+OisiCYT
iHaNnEm+CGec4BChYQUNTX+cwm58KrumvO1Mw4aKb+/dd3UJ4bdy3PQDNoESyRCzs6dYKu9j7CYT
6TNted/FgUKBSGG/0fPUXtj1RKsBpXG8XdIBBlwcG72znQpNFlF9cFp7nQboJ2dAKiLG9Eg3sSPN
y5r5ORo8pAbQ/6+LVe1hssj6pDvwi71wBY89zjZth8Vjmlwy4nrs0MfcV4TAKMV7a0hmwrWwhseE
h/ZVfznHTfNlIHLjQWQTDE+/7pcnpUJkpXaVJTu3nHxCpjoL/KSwz9ZcmEPJlUl57EG6zu3HjoL/
jgX9zIOys+SmmYLs0PUjeOwJt/6uHQcEgMSVYstlppet9WwDrfXPINBQOWF7wBA3jpzfGf6ZP6Wg
HQJkpSc5h2RTRAvS58F1MZbF4gGvF6xEQFPrKDXhrm0ms28AVuzaII8/wCR9FmWqD3xBAzyYEuuJ
U1sblFzAjWUZg0S0F2JiLBnNeyJ9ixPNYbFXDgk+NQNgOslNFg3XPvvD2zq2x49O7I4Fy3EwfpxU
0R29pE4v0z7Nr6oiv7Lqufs21lD1nKz2oJ9H3c6eZgPgOXBoZI9us5/j8MjgP6HHlGoJPikh/8RO
uMUIDqGmsnHiVg7AW1Mu1rNHoTJh91qWbzyseHZsOr+fs3iunskTAM/Se99lwQaTr9N7/dZalO7Z
rowUV/FPr7vE+eRZcO3j8AUIh3O0IJltmoIkyqTNlv08CFJZyKbBA0CsjjDV175LR283eWA8LTOI
B4cqeDPkeXSgJq+2xWxezGRFG9ESjuD2yM/HwL+zA2l/6KgBjja72LVs/PG6G0PNMAUQZuAQCR4P
ifvJtEF7DQSTVcfq0BcDTVu5GpKLsYdqn+vWbEVOqHXmdfXa0vUlcYeS3U9LlskEI6kr4Rd4KWP9
kkH8dq4L8VmPib2rdGhfZIgG1x3yvPXgtYcgcJhpeQO5QTuF7ZO96FnDHefBhgS5b40iVSohBWc7
DBY2btHNh8IBJTw75NtkAAO3uR92NUNoNX6bR/2x0k16TJluHQGHhCt2WfdOptxXaqzyYaCOvE6o
PNrt7MxpsR09a7wPNBtkpjl9BUDCLtyrmZioCWwzFgiSpTAnrdzGM+hZTUcmt1ViYIGcZH1gnup7
e4/hCarXAgfRqoKu8IW9j4Cn7y/wW5z83la2/DQ3dUumW+UgV4e3zjkT6SP8OHiMSHnRVAbm3oZu
TG/Mzy7iUn7ux6G6H6OJfVQdDLdFVY/HefFBSzSuOAUO9nzYoe1DYHvDOinzYhNPMCIm9ApPtdN4
61ZB7oDB9wj4QB6ciEHiys4iyHR+dtUjs0MqD0wX6CQfYqgA6JF1BmfVmogbr0gqgRaYXSwF6/Xc
sQtaFw5afaTI0/XUuNDGW8aTatD+5VRHzjEJ0q+UxsldShmyhj0j7wrdca/zhjpMhXR2oR2yKeM+
iWhA1OlFThTHFqtf/JD41XCNTM6uDoPNaAotUP5F11b1qarr+lrDDFoL9E2HLK6tZxqnLOJLVuy4
o9304Elr2dGyxlOGeUO8NiOxMovrZttKE/CY0cfatj50hpVIGSCy5LgtVR4r41aX4J27mAF0mxKG
2jXprUyz5p6ZdbqO1ECpaM0w6AorvfJj9mZ2MbYHdDHfY818bT3UrVPuW4QRKLrT6sviAq23CRER
sKPAJSAe7ustu2ECRbIGH9Qco562xS0hSuUxOL9r7Vq2J4VX/moapL6mrajuWqbDBYk9rjwMUXDK
ixC/D3JZd01Vw+B7SgTp87E1TlvDBvAhSrwCBpuInwll4wGMF/s1oqHBzj6gXCWsksEh0ToP2u6I
K2H4LNfQVeC7admBN64GtOXkBx6rs368BTm2D7V1MdiVWIUZ0UBh1ZockhaKDwB6dvfS0ys/V5PD
ppiGcv8jLm3RifOlTW35vNCLaVcutp0N+31OmNe653ixGuBa/JJhBq3C1FqnwOHv9SIq4ljxm85B
TogQriUI+Gm7B3SXXBAZWa/DcAJ80bRivrTIX0FKPxjzZMu6Y1LnDrREDHDS0j1R0pqPVjNPz07b
IggxAyScibE9VZRbfQYyNN969XnCblm5mXDzLYvZ0G4kga5Lsy8ZyRHt53nmKWd35A87sn3JgSua
Un/z83B64WU5rGMu7GU7WAnJkz5idjPO+qHXsUK77dnlZQZxkBVT9lgLEaKNgBhRyJxoGQXhZeB4
SJJSOkdf7TGs3AMpIzlIh8gxT4hcx49ZqoiVFBQvPtBb2KpOV1/23Nh99zQ5YhhrcISasMQaMbXw
uipXKMnbCM9K0U4jzoxIPCWD9HF466eGN+2V3aT5C70SthwVwGZ9m3aoo8pgI0EMl8C+FJ/tOPyo
YZqIzsA1uh1qyWg4G/3owHRI6hag5Z+MyzYJIkjM/5VVVRVXdeo15KDNAf9lbqOgwDDgmqXmCbPd
ZoDFXdr+9dK78bIpaiJQPoTkal7Bsyicq2psbOdLjy0+vVqgIQZbxGCw2NzY7oCJZ57FE7jUSEFg
yWY0EUHap0RD1FxwgnTUxGSqgCbHNeGDUSPEFekY++pH+czCHUzfwNKm6COCwBBm1qQOhijBIKDd
eWPo5S+oRbvlnhCnjKZeBbvXZqQLdWK/9HkTnbwFnAr5Qsvg3iqrk806V1FMh708547May3qmRLK
Bl3CYogU0g0vwIL1jLUZjFyD3qaOXxITxF+WMle0NMnD4mrPqnXxFcrW9Y5ggeR0IxXuu6vUtRWE
7AoxCWtrFlm4Uua2pD1R1aGk/PUDld+Oi1UR5Oxq8p2HlL003PEM9zDGSVrfNvYffehZaZhtDEE4
PZkwgbWzFgMBBVvGBAGZtKLDn8rWlGYBqBBbXMyxR8HAVAigykpjRiYziaiZDeIknV6NxVQmryQP
VRRBAzv0iwqcotgtve3gK6fH3M2vi/CaBbNSuHjOqwt2vEzWU99yPwkRnUdmZcmJV1bDn4E/OMO9
sTNAgXQ7F1rpTqDbGFC+XSenXKCrREzJ1vYTi3Eib9kLJVAiG1HfyTITz2mkHFOvcqq1hhpeNRMh
3ZTGPDkQBfzgvJexnXkLgxhuFAZd0xPVB+v1tW4J6v0wpr7i0mWM+vmHa5zzzWJmDVG4M4JILJGf
A0uXKoBQFAVsMT+0IghpD08kCa7cZUyOso3I12mChEVKNN2i7vpwKUm1g1MApI47OiFeS4JKtUJn
KW6TJDmPDFrIK9FqQQFUHFGxik9B4nbztGrDERbYQJ0I/p5b48ArcPSRuirX2p5liPoKCJgGzlzr
Rd5FuiVLb4wbBqRBjuAAV76/S9M+71AdgIJe0+zwT6LpJ+IKszP0IUpDLqaDPqkgy5EdAe58SA0M
x5Ii2IwtOr31WFfsrVj4pvpYIKcg3c0l+4Q9HzO3Yzt6i3dEOFVEF+x4hgGD/o+pqP5xWRs1NeKB
xCEfhMLgQqcPGmPXBNpYw3IJZtQZViWWu2E3I5aSW38ZxuJ6bOsWnhXekxM3l+Vf940uLxaO2Nxr
SJjVs98Ky9rMLqGNNLKT6kipKecTM7je3SWN5xSHDOS3fR9B7i42LIRm2cCPGMAtLM4ZIqQBx15N
mpgL06Lm2C1s9tnDFlgULimMauwiNvSObUX/OMHYJ2Oau9pvngaCSElqQlxPd02o7uytX8r2m05S
TaYFMrWvGOGGWyRi+MdmKZr2Ox5VnbIpLbnccNXzeaNQqz65Wc7zVlZ4g67kElbfFZf6mR5Rqg6d
P5XzzpmgYWyQqgdqM7MwwBPnCWOJ9ijqDySKcmt0CVS1nw9n1wjuUc9u/Ppgd4sbAb+T7bgQPC6g
4ILqpDGY9+XSHmWSm3GXsVGE3NbQSWQoRB7aFhYzOR1DWGBnVaorNpEdTvPRmWUT3igymupTgh2a
5LUpQW61At6dUFd2sfCQ1hXjQv+RJCgyELlx3Z3b+UQ6YMJKTtj06/ACNXX16rb2GL1COhELnWcJ
BZ4Tp+ns1JZU7pGhSJ5/0g16qA0GUqZ4aZOnNE7DMmM0t14UX+5WyoFLULk6S/dkmIT7UTYyRFc0
dIj88zCts73p3HI+UrEzHl5JVtzkFQkefU1eA0RImsFLICAam9t0x/iXzrplKiLQwLzMj/VczJdy
ThmKM4hoWD/Jo2T1mtKCfXfSjDAiU991cpCOiV3vsEFbMyENVSmDx9iNTL33LUM+FY1ydtqs03kw
3kD4DeMbfwLpvvNIVeLN2XWx2k/ZwDwrMtBF2nWGNen/Unde63Eb6bq+IsyDUIVw2s0muxkkUbQo
2yd4RNlGBgo5XP16qwGvZTZnkzOH2yc0KbIBFCr84Qs8gyoM5JyRXs5zuLw+jkCj6afHxQ4SebSw
QEhPpBvBNyEq/PpYwWq+ijAwZr2mVYMZ9dLWLyiMknZ3bWLJa4uS2K9N7YfjlcjSHNTX+YxYW6VT
EWMYUSWp9SQTt4oeGCRZPVZiDilZ0EztntUcdy6emXrHhNaWWd+GxqwwUsSyR+5nMgus7wzhDPGN
0fa8uMBDROSICaSld2CzjI828K30ZPMqT2qIBYqivdO1f7iNHaIpyYnH7oNxPAQ44rBvmWh8cYWZ
efsbHoTmcEAbaClRj6gQSkW8cOpdImVesknMFtWpcUQvi2lhzbiM3BiQZdWXUdC+oPLZTQY6ZMkU
fDaofIa7pIp6/3fQaDJ/EIgs/6TMUM/3rdEJcZVyLA6/EBHJ4WtE5Lt8CTH85alBj7J8p2o4idRA
DiIvI3P52jg+/+gCLdKyJMyk5IQrQCx+pthw4yCamBySd86yzPWfnCd5xoFiJtDSdtSv0Spq6eer
mxHLCPMoRasLwkZvCxlckUKH07iPB+yWfoYFVjI78L5xde83sqhivU0hqYcVYLXEqHDYRmheWQEN
hfGuRFMYzL70q3GmOu8U+IwNnPS/N8WAqkc4uhrEQ3MgoEWQBOBQdhZlc+JhrB7L4anFC1g9kkzM
yQ39WOnfe3k/Qq1NETtEarBIf8ua2QLzl/Vo3lLDnuhyHMui9q1P1J+K+kCm1zm3EU1Tiu0N1MLn
LUaSZu8Qdc2RK45tgrEXfGjT9DpWcVEsnyIzG/6wkpkdwHAt7ED3PkGl+h2kbgcV3ByH/CFKDTU9
+Qq9UiQ/e+ZZ6QOK/cVMA4lNe+opdTQMI2rQcZuy/mkxiWnQgyLrOUKKNZ5pNLXHcTQRuIW5Uqb3
4SAHpHHRI5wnoDtG9Kfn0fv8Qc5qlL9Gnm2+eIad1j/N2QrIA8cJTRfQtnU8EQPQs4xBfXawCF9w
nhrjX8dgqkOUXELmRkh5M/iLBstUH5GZDocT4riJpvcCQdY8GYuIqMyc7KGNCOQPyMm15hNC7QPq
bXpgj7jXGd19WVBBQevODdT1UnR29l3S52ejR04IELIVx26bXzu+sAXtQ4KuP+I4QWBxB1bVx012
rmkponxORgX+NWJciy9ODeSJ/iQ8z5uZWx6x+XCydHlUIW3puwqR/vYFocNmBlgVjQmYHbpQ/V2j
bIWPKRg7SzdZkuV+aTrb/qSolJfo++YDGlTI0ksZapmAbv61knmNpGZZyvGhqLtSfB0sDsdj0Vjs
zTAMiEfSAI+J22HIS/BACj0jZPgNxCSTU9KGVfAlDT3hffLRb4VLPhKxILpVKEuvevwC5ztyBuTy
TLjN3XdPwgA7UAYu+hazhspsbe3721ArxCoUSkKP2yWOtQFWu1F+KMBUGOqzYwydFTwYuLdDSk5y
At3+gLKMQFL2fWzHBQpQp+9SU1IE7Ec3ANHyGtghiakbd2imm6EqXOepQ6am/V6mQmU/pljStAss
Ou5fFoS85a9BHnD8nG/gvwKP/gcaev8Zd/X/I6U9B1DU/xtZuv9R/vjjFWdV//4GLJX2v0ByAayz
HKlBXTYvdSWtGpaw/pen6jv/sihF+cKBrsH/uWCjNiSpsP7lenwGUQdQU+BL/w2Q9My7+T+QGxgo
YTkeAD8hgbpZ4Epfz6ECUURFZyf6bgHix9NHLS398gM6fD4mU1lZRxGLsR/D+gUwzQKGBf2dvET8
SsFHfB4Sd6TgO6L6XndXXWERfbEs7LAEaEQFN52B0Xd4vOwaEDwArwGkIPe2h2/gRFQSCzwuECZz
7RrJd5UXo4MFVuRVJm1DDss6OqTgArivCKok9xUZox2j4BCljguFvaYDPtwiMq2y6gA/xPQeHfSf
tcTRbA3eH0DYrOob8YO+u9IgO4sOLlUELj2hNVaALnChWNBBk0XU2UejzULvyXCo6rXEtGFnAn+k
59B7N1mIiCiaI5x3CseBUqXqj8YE7zpeL91YTR7W6T2eoXhw+wOfX9eweoZ76rJgCE/UDUK+E6Sx
XK2mns9jk5ub3EJT15MwbvIJlYGahg8VAG+PK0XCY8eAP+qXf8zGf4PdfY1r1K+cSMImnRHCkgK4
7OtX3mSddHO6d8/44E2Rd3KkCJeRQv444AhTo8HdxQc7WrJ5xE+2WtTyZNAk6BAmJuVwsw+geK93
MW4HLU9w1LbmZUMqvkQBQgro7GCawm+YkrpMjSklaSDCcUe6QgflTnqohjGGE/Vo2LkibJrQyEOo
4v1huaAR6RthWQKodnFbYHT0yvwnpHnxxyTtVet986hkyeLTgGEWAq1NkyWueAx4IaGLlp7GqeBF
nS01wlNGPVhMrWT2xTjjJNzrL7Qng5EAuldgkT+T2c6O8bkgRvdfKqfrcU+gYMZZ7dP3dR/ff4rX
UFkegj4BsSzLmSzSoUb4+iEkvLMantH8bcK7M0YUcFgchlEgHR3MN7EDToIip0H1Zqp2718aqCgf
/mozgbqo2e5MLVjL4OZfX5xzWPQxyjnf3MLt5/CXHgidR24DjIB3GDq5vjidYL0GRAXAivI8CrYB
1sOU0UrnkyLAZ0XESaRX6jDQAxx3fVtZel5EgGe6K0q/Xhp8rnpEneUN4A29ncCWrfhMt6lnhGNs
NHRBllfIawa/hQUUFfVVIQnKKhYxchwE2bI3RICqFvMa7SyVhm59PdsI57JwW+Q3MX2YKHjQWIZ2
zb4z0wfmjooWGArmA0mi96QQCWFePgoE5Pb7hn4uBfPE82Oc0hTwBJ4E/iWC0XjcnD9lqOkfDbcm
pqU6dhat3ljw+QAOA9WmRAoKs49SP3NKRF2/TIDrubioLEvEP9H578f5rsUAfVRIu5VmTS+bjmAN
/GVhpwYR2MY4YkO3gl5kqcSMcQ9vgKsgb0ZY6KnkNNMudL3HVCUZr6RUXjSEj0qrCRk/qnWDzKGz
8PKmGp1y9Rsxf85HO3PJeH83Mx+sASEgWl3ZMQ3tKkX9XoeheoNdho5fHVWu79oXoeK5gjQajCcx
dHpXgwGq77M2ktF4KhX1J6Aj0ovidG9TJCis6xljyxYRLpTKZUAnWtvEHFQ7OvWLm3YGr2n7qEjr
7rqf6czp2QTYDn+BojCxTAZ61A7RjUS9s7N/6YEi8lcJgOc0/94Now94JvNGOKW3WVzqeTZ2feD2
d7Y5o8P0WIZ2xJC+vzbkm00XpgRrjyOIo5bFcbE0EG01aRD43XNFdR9pvHBZgrrURsx6zzPqZmLI
3CFbmDQjji18qcqaKsFh+xUHVmFdXzlp0RmPIKr1Ye1UNlCCm47y0/g0NCGWDld9DlbUuwlilAmY
hg181xuca6OWBjftACmeUmuSCWYmZtCqSj51FWnR8hV0eYtG4QQ61L2vvYXEc9nhr157/R2tH32A
rnVlVOEjLrB+A9dez+9qne3WMFuN9Sn1cTtKbqQYdElDJgW57y1GwKT+X5RV5Satu7IdkMf9vp12
1mTPPLERKSh+yHUH5kg7WM0l74PjMeVZ8UWIkLGPcFgyzesyxcTEuycHb9qfSPCPLFySTACH9w4a
jyjCgFSjoXYrMxGFwaEoLGR28dCyShhnmRXqRS2VQeH0w13w9SbowzvhUDXZ/xzHZSe+eNN4kDns
STLDnA05NBOZOpyNk71dMjkxGZSeHqJQgOCn6TIFeZ3ufCuNLXnnAEhjV16q2kzEf3m6+TBPONRw
F4bXYb8N9DBRsiUds+Yb5ciRhwfJpL/kbR22wQNMHqm+svn6Ffs1LLhp/EnG4Kn5ZkIpITZ+zrT7
gNMF1gRn7waF8wF0SkkPi9OlmHCYm3Y11WvhPRgAD8SpidKq/YgI8poxoNmT0g00x4equ6clK14f
MBPeDb0C4/1k0QRHJQnfziVCPDIjtq3T6zIEHOWcgDl2+KU2swmz65f3F/JFtMIdsI4tmF8OBQUW
82WQ0DSWHJd6fEJDJfPk99GcJjlfGwGcFAodnpMNM5jgpuNdW77Qb9fzCmeePqARvL2PAEESiPQ+
2R/SSBcjgVGVKNy6Vk/r3mhLGgHZkZXPsX+NLcPEaxlzO9ALglVPONLFhY573x+Oi3CDLMbErswW
KHLDhINP8fqFpFnfNfA1Wl4I4pXU9zmqDdQMJ0TMbf8vt0uLNrtLxeR50QdSHm9GgAsT6XgCyXI9
Chdh7DJXTVZli3qKjcRV5Rc2C49NipKmwZdt83F03aE6OfEwzM8oSMm8+mAECJ0vFrwl4VawqiAM
2kSyl2Mw5n7VZkWgoDX3dCw+OesCi1NEt/xj3nVs5zd+VjUsty2IKQoUKIf7uArTEZuaUi4YudEw
0Vt2ZpjEhlipcuTFndQHglDy/EzrBzsEknF7GvM5bCOKP5NsUEFD3LrTSgJG1aefuxBYvHEAjQ7r
5uRTQs3cO7scdKAxUv6pX6Th68AB8EVlNFe5jSFB8xXPHj2LldngInlLhpTDYcYKlqDzOo1Nm1sB
nKhDnw7beb4Y7jjqk2rd/tOB2ffSNosOctoAFb72fpATno5UAE19aFiIkTnuDgYSfZRre2iX6ls5
LQ1njFUugjN+PQEB288dAumyBgHS34HuKrhZUUlSrTsIvKSJ16YVGqH1HcfAPMPooupQDgsxXeA4
6tKIZ7yWTkdOc9+oYgEL2M0o2kHI98OQWiWIBoWAsfDLCayNn/caBLOkrqG+MS4VJ+2S6Jd9TT6Z
cQuLlBD5r6s1ZhmbAmYl+PLOA9zIhp/wb4t2rklucDXQ55UaFpNbSXraiNMDzjzITJxcoIl8mJyw
FAt29pqqGqwufnP7A4tlzUQpNdzC2xOz6QEOHVhDyQ3Rf0KMWMRogT8NnUBK/spMBzFRUMV6h2AB
SIm+aqPgIjd7e51RbYnGK9n55OacpzCqdaxhyZAt9EBAoM9qazIMLiem2AZYvSSMVXztFCUOf9kO
Fhb1wV8nkBhzdNf3lPSQlctTTEzxRK2IR8wukAvGepAEx79qqN18MoGj9mpCl6FKR2Scs9B09lE5
dCRTuCkyx4FrpT56nOvSWOjcsj91S+ZoyGMYF4Nv3BdLBNoGD2GUmMwByg7Q678K8gF72CEJ5gTt
o8i7ZfJumyDQcVtaQrKIjoVf5lWLXuWQsHc8G0I3MW9RiQJQBeQU+wqUG6bWMfvrEKXT5Y6eRZao
T0U4T8H8xIpZtPkVhfwwwF45d1Ef3Re2qOFyGCGpbHGy1vVE3bljPItIFbAE08GBObAnTHNQcZ0T
R7eevKjRicKW3WzvG1skHR6VazglpKc/ZTuVjd7QO3fg4cNiH9cQ+v2N+83uCQLKhonMaWra6KFd
bNx1XlujKIH5rucHFQMgAw5PND1KMPKcXsIdY+5dGFlMHll5A2v7/Xt4c3j4nj42AiITn1d1Seus
sekEX2sMj6bd57jgmhVttRl81PJslA65zjV25znH2vuXPQuQ/CNNBXsQuODn0QxBKwA27sWz+7iN
GJU3Rk+eE9BUeaG4DhvrCpblUHffCuB5Lg7fVK8yrN2r3uJwSXGg4g0iv8t4XQ+mBCuFfAFezMhR
LkU7ipOIDKSTb5jFTvqDxFLvBXg40dH7HAyi4T06YKACNu4mkURSDrolCPH6NBNy+9G1Fz95ojWg
V6rMjJmqS1giY4t9Wm/roHok9YattsaP0RBPBJXbbbUY73Ls097WO0KOAnzTPPmzYdvZfqr7GoMn
C6y3CfCpDFphlbuQiB6dmXTxF3hfBsocTfjB+XwexlfDzDtFXUwSDgd4dlzyZ1O3GGUSdNDpkjDw
sZ8tANanVJZsNRmHUaAJ0T5YOGQGGjEW15i2suVBR7sLUCZalm9BbABiPuLBxaI6FHXu+erainCx
DY4ttE5GCtUHi3Hg8Ai7dA9TsKbjNsuGF1inZpxCedIoTusaQ0CFd5BNRm3lNwknBPr+uQMD3fwg
1TtzR//53DD8NWs48DnFHLgcF9PLcutxjNy8/xqUC2zCHylkA8JplJZ6lpVTWZr2bvljzwQBEWnr
91gBXWuuYLXY/i/dBLACUWxX6oKAZbasB0Vqyy9UCucwvC3nsO4AjyNSSpiH8p3+YOx807S57Xpr
EuMBgVgmm/aSZxu78wILk7ZD3EFUxPc4DGamSzHQsZR3XWnoQx/BuSwRf8Jkc6HQ4d7GnURKTXFz
1SZUsoBpq3HO8oNpZAjD7YDZ0V3fq9iGiFns6tAM+uRxUrCZ1ZFCSoBLkkeQYyFz3ga9BWBMcqz3
KJ1OmH9wYdWFy/nZ6f8DC0SqB9zJ+0v9Ml8gzwaAIggU0VhDj+giRkxbOpPIBQaPjkiGQf1K4SSb
HpcY5xaJwFajc9c4HSSjMdm0cT+qKV7ucBScTaYAKb/OVt5E6VXNkTZnhf/IYsuXZ7luqbOTe0wB
O87B8u3Jk9h633/uf3NdWkNWEHggqqR5WVOVanSTUSzi0RQG1xWq1eXy0a70MbSSjb1cWvzs/eta
FxVAwD50EwL9xIFuclymR3mclFODsN7jYDH1tVMkreNkv2UFnAOxjddZgYCGAZi7mZT8UuekxpAi
0hgfHioJIvWaUxXTWca/oiXc/JVKjj+O/QcZlKXX4at1CoeJnoFJSocWFqfh69wlgJbRJ8KJH6fQ
70nG4aTqiSAat/V/J9RKo+AKpEvYfEuHltLYvozmKf1Jmo2C0mnL+EKFHi9+rEmXpyXIHHgs41Wj
QCt9pNZ2UUHCeZp0EzQJo+sjR3CZ77Q1hLCpLOQXOUMlwWsjifUsmgTcTBtdJX0+JyNcoytp9zZe
mSZ+Vxzg2JSHpH/vv+g3E8y2oZW7JOP6P++yh6CjsQ5VneGxdPuEtWT2wA2aPaoVHtdCKJM4AtGC
5EPdkbejgKgrSScKKyytN9WVIJqipYHl9Yj2j9GdymbQVe6ypPGME2gndZUW2FxPz5oQP66yxy20
jVpHHxjQtUOiLnxZdf4Cx2bhtrfCZ6FqFJGpxky63mwPcGeTTxYWllgPelNREZ+JasTl5q/3B1O+
mYkAPDgoebfo4+n6zMVMFDP21kM6PG6F70BVgfu5t2rctw+Jhyo2YHZqxkuJCp5bZ0jjlzY4DzjZ
uQ5Lola7Pe26xraIuAfSw7xiHlMV/Loo4YXGnuK36xh7rBuoEOwcMQV2dl3j65gbOw8dc7xUvE64
GT5WHQ3r7tvgWKaJnP45JrNHqWvhiYh1sbKhdnb+Qs2h/S0GoCkpAXttGqFAO8Mdcm5cIwH2uQvh
kA/lAcAKNte3PRQ942mpAAJ3L9vrQIVAF/4W0Fq8OIDWlUOWKKwq4uGi3MrxQlnL/xQyC2bzVrLP
p5gj8KqnF1fBIQXLMeN/7lT6/lAfwFDihnTaL5D0V5kvSuMUFaaqcCHItP7n3oPrDxX3/ff45rSh
HYuWBPVzFF7ezk1XxtEisPF+HEpHr1CQfaS0OYBPHbipRI+hZ+VhdwK0Ij/cfN9eXi8KsCNSVyQo
ibyeRcRaSUo3RT1uFWNhlybnC/Aal+vD3qCjgDKAw13kUcpL/+DxEUi+2FA1IsF1UW8FyIuY4sUN
xJ1IU2upgS/iS0Q2Cdmm0aVoJ+pTSL9jCO77ittZSIFrKju8QMTYmSMHAwgFuduWAhv2qMuzPRsy
PwyVobsl5dp62bKmuQqYS3gpNKa368oIX0goNeerbjOrELluJTVRj8LGEW+eshggGHZ96l51gFkN
/D39kF0D6Z+kjAvjgx3yzUblUnLVAoiwzgWJ1sWaRq8ms1t65F+2LYqsT/DKt8DdoSpQ4/UCOOnk
uqXDbEHvv5wex6L5MM96LTkiENVFT5ftmnI0Crv2ZWMT3fQcR8h8+qUoOwN/a/YyrjFmPWrRbeAz
H99fBxcil1zQ0xGA1nShGRlQKX09E0dDunAs++iXWIQAQfeWSRMUtsxMkZCQsYqD4ccKrOvaLqzp
9bPX5dM+MykFgSxW9MU+Wpxvsj56owyBjgdpwbw9stoJWHlVFTGkgUjvJLOT4b2JBpSrA/E1QBvp
xU2PykDi/gRbSwdIy/mc4VgDXCTjedQnL6UghtFdMPV6AFel3966URYRnjsoOrYoJ9wsHu/iK3Q5
uvz7Fno+Xe01AK2JnVmFLbyx6XFrHyYgtLgrtyiYEjniPCDj4hZE2S4o0LCqd8rDofgemH1nQk4y
PCWvWojsLO3aS/CGPSIYW5AsD2N9Lic1ECrJjERhcXt+b+icflprpO+/7stYgEVP7x7cg0VEEOAq
8vptA4JKzIB2DGat5wS+aDww2VViDuE1FYAZiwCJ8Aqr/f3r6u3k/+I3qbtpIOgtk9nNZvsmBrEV
NIMQluoXvEmCCWX8kCZX/kwPqtCS8v8L4Pk3kAnK2q8vxpyxbc9FbV4D2nXZ/fVDCrxzUKttvC9o
UoNW2WUUmHHGiKVSTXmFKCJOjsfC7nRZMJMm8yeKlJVKVC57/UXlYcUvhrSPeWOO2UzG01rXGaAn
6N8790klcE2+QaaJHJ63jO/m70BZHX6WssuQ7VH11flj36GIHt8JgtHUue1GZzIxE8EHiN/kaFy4
DZ8uhPFktfS/mr2V9v3wPFpJCk4ZhQ+VYvtiUEEEyrreKGqN+sG8ydZ/HEaml3+Kc1J3+1SMAO/t
K7UstNp2GWWhycR6yWkDrrn2V0v6R7hAyCYKgvwbwE09ECNZ0TR/R2UNENvetrredKDY+0My3xZp
60IGBqouRX3nTi294Ufg7frxS1HXrQCpk8WMWdIWGgkSByRM5c6qhyWZjigm6oNsIH53i6OcWiVi
GnouTUyYNCaGbwcEBgbuOrZDVGTuI5qpvLBF11DNE/IZmE58yYWbWOl1NYg8BAxP2ErlOs5Haq+P
GGg77u9h7utbSRwMC4OHjGoUR9L2DrIlo4AIrQPp4vDrto4DM3OpPZfZ2MbqUDvO4jifeoCIatoH
oDspADmAbgFjGE2k72+hGArcyQrysQgJaDv9yo1JPzLV0RFFoNakluxcxeC6efNs9TqQqGRFD32d
QgaREsNtl1bQG5qMgaXpVUUPsokPWr6LQRSWapmhONQ6hXHMML7kh1ufaGqQ5w1vE5OwezqCl6Bx
htCt4bXRgzkgPhEh0BpRWr/JZjw3vU8KHvsU/xKHdtE2z7abSa6uqIYzGspDCXY+0axlZuI5Uuv5
jqev/rfBQb8HuL/qrPstSAFYQcj0MHVpLY9GGkzRIbJF6yaf0zrOuMc+kYo//WA9n4+gf2weJOZs
WaxqR1icVW+0x7g6aCDo/18GIgHRXC0AlAxn1xRIeMCuL6uJ0NHpXJoY+xWMsaE2/BWfNce9JQtK
wpWtcSW2q6Laewa1TaHj1zFk6gCnddA9IhtcC9OAQ2jF1+YMcQOhLQpyFQxv0yi9XS5isB2nSbUm
owvi1dVtJHgkHAgb/i0wY4qjKEdxDCVsyOz3y4rYk3wEvxcPrY8lHRyOCW5kLBpoibuzAs9NNEJu
RuLUoO4zwrxUDq0IP0TiFTFSAwtAZnTX6vbB1sCv0cSi2Q7omroeJfWkRK71QJN6VN1dbuGrG/z9
h3Bua8PfhwjZa6fTevBmCA/dIvgiHdHhCbNY8Oi/b2Fc5KihUNeTIwtI4ZXBrAdIs4Z4sY3jOAo3
507QBryxfU2cwcW3CZvPi0IXEQxhmCkAKmUa1IhQ7TAf032zqo2Tqrhr9E4cE03NOnjcYsh2iXCu
7/ZGAYOGJBC78yr67Lpdga0sEjRDR49mix83UEgqW7HUX1KxSKs+giDWTSq7nnUjjiQHg94rCWba
TG4oESC89LBhW8I1eK1LuKLWp62BtyGMbEW4xLmPqbkHnzMOAechOVu76W+tRUWyPNitXPLqVCIz
QwC99Q0CptwMK3gxwC18pG8vXncCpM2+RHmMpU0Dk8rlZbAmIGUQe3XR5zJCl1kdOJm07SKnEiNw
aKlGMEQ0FfWms+T0kD5tqzlASqbANxaO71ycbB9fOth7Zt/3mA9Jo8RRFN8yXLkab6LSDK+jRN8X
Q69nxI4XQi8KslS+cOvRuMNxbvQVdPdwegQsrTMANyj0zwIR6k4EIi26a6OQxCmQS4KNOcyHoafi
CMCqb/SHoJZBkrrLWvjBL/CRCcYKUWR8VM0+QmWiBA9OHIT0rkFVH1ChRu+BjHIIleox1cULYzQp
BJFFn8FnJFrcY2qy2j+zUuiz70ryZLg9XgAgFp6k0bCXo25xhrhNEVzDfRtNIbLNGcIweXzd2zDg
cZmSLQkY3CWS/UeHZmz2pEbAsac1DJyKTLfuEw1QqWi5gdXBzKyJiqo4bP2DrANihv91b7R0jSde
g7pb41YlTP34CDVoGATOvm5S3Q4jW1911QwFeUVlZH48wtpfqGf0eIgWOrhtYTswem6Gc/uDMNXM
z9zcJIygYX2uhm21yqYeMmJLlLEi1zulLlL8IAom2+SU8tAjwRq+EnlwLIPQCubbdJV43W7Yqy2f
2+oa7CcoP4KV5JqmmbV64OwWaPyuKPO8IYSNK9So0ZbLesPeVakTRf1nCfMHhRZ/NCEdXduIDFA8
HjOha9+JN0Xc17wOXl8GqAs+Zgkm19B8wCAmxrWdYDRIpR0/Acp2Xc+/2cc06scgekyGEa/fk51W
bnyKQSZzxiMZ3nMBJuXEkJqGSPlrNv+a0ADfNXrng6JJa1b7xIQj2zw3LgJaNqv6DOWCylPW2d3s
hSU3ZlXsr/ZxG0yAKWJpDj4tpQXJtggJsgolHkNHA9uf22bfNtXO4R+RFitouFafQ6+htR9AV+ft
O56ruK/JL3S/sEPH0F2Av7me+jonxeQih3ZOYrwy1BgQ9kum2PZNlS8tf0u6q996J6ZkAu52hvBs
jZTMMvzIPOKEsXS4oM6WUvE1tB7ffFIU0zLCKWk3ujflovuI+q9R1aVzJyOrjLt9tnbJtsVoJiVk
zx1sY8tQV7Cs9HqJ1hc2uUJPsjUTDRR9oezY9LmuW2IWd55r/bCIkxb6Kfw7WywYis9XVRadD6bt
wMiHUXcQVhL2kJtsSNcUehNZ79sYQ7YnGhjWaN7WVJhn9wAbfcQidXtiOaKs2O2mHnpP+amqSr0l
kQxmHQIkbt+XL/l5GxlZluwHHANqmlCGQQ2ixzs1jZbQv8sVB9h048UR7bZdYhZxdqtshEywnwdm
PgSfOvIR5mQ3SP2+Ut+t6cGPa4HImGsNnwokc5G03KflCJRo5DU9Q1K0cE7BUfncqxkGUxedt+6f
vSArQHGd8rbevthQaDOVQa136pm+Eu94wyBnTa/3HiOj3wmmmmfkJrbRWzoDXz70GGqzP0Ff87+A
xEDNCRatvh0LKzieezyHHEVIbZQ6jTf2FrGGh8ukeaiQpwsV+NxwcCICgiYps10rbPT0nzyI7vxB
BqlvLg9Z36Mdc/t35ZrqIPcd+oZekVnYKL2g1+YExgB6Y3LK3JqvkwIO6w/UMeD0CzsLEB7t3LlG
xTltW49RtaYY6ne635bZaIyhgShwMjYL5Sa0LVAOyr9AgY9JSRHaPK9lNI9c+q9JlekZ7FDtl94p
mXz9gMBnTUCvjU0Ub/4NvfQWeugogso8bvipQnJZT33Mw/H/9RLS3SjYEQnE/amWPahcHxY8Cyyb
64KtIOJp2ULWzL5JhkAhYUZIVpdfMK7XG1ZtqZA7msid+LctMtuaNoYLm63YV8h45P7z7Hl+d4oJ
5XhD2/0U65lmnxuF6JwJ5Xzd3lefg7EBiNanghSJjNDQG3ZMR1LTJlLg6t31WMTUhR42sFiOqqPe
JlcE2aBiPUHHsiHi+VoFdW3I66QGvPpnNJoUkcJEN68wvqWQMZ1LV3ETabzAuFYhWrDRzGm25/Mg
s/XznZ9GiFHeFwWSyulRTaQ85mHwXIpBewk1fxxv3LjQiw4PBZvZEOm2+EtOagg/OlgqH+ffdZls
D9jBH9azxizOUMu81NtCC+yhftm2GArYLAAnSHUBbDsuw3zUVwYyJBj9bccu+tHlkVdIQrYWbWvl
61VkIxjL7Q8uANMSzcgy5RCEe6WXnbU2W3JkhbmOmkqdv/XrAdmUqApyQCyVjl+2znXShLofES2x
hoVuyWOdKZ3jY9armxQR9AG+q1wCB5Z5WujTv/dh1uvu8Bmdka074HKuHTbnetK8djcX0Z9nnefN
ILTr3qFQf20bfsfmIPtR4xO3BmhqI4cFdnES1L7sFfxRTJO+Slp3eonmOaaR3slD6pSVWgip/9ql
u788J1PYhvLUsmuaE8TwLAS3sj33Nom2wdhWthSV7ni3a4vMn7ySmbU9/rYJB1gFQwjtCMQgd0dY
lheEMRagZW8f2wDJTvaQM37X4xr8lVgmcHDPkppZdTd12qjkHtJoNvYg/WEk/kk1ls3yCru4jpjW
bmvP/V3wQ2LZtZxSD6HjtFDFsy70dmUndaEjEr3OhCWHB0UJ1MJ0KgtUxefPwl6/GmSdqBG0ur2D
cEkBwRSrV98buQizuiFvRQ2s7IIHbKFTXcooHRScrrAk1V8wvgTEtuOWwukHAkGB+7uGlvJgjj/p
hdpIn1ukU8Xt4lVBrnUFXCav7Z2bolb9Le8TXbJxGl+XbFqkP/mjtYJAANHyzVYziNaKkGqUPvj7
BAFWY9eJUFcP38+sL7MJWqp0Aag3m7Zjs7gv6mRx3jRl2VXOpzHhmEGiLvemFCPajKF5gYWiZ05r
j0uVgLYbUie9W+fd+3fxuhNB5xvwNb6LnqZFehwxumT5D+n2Rte7syiACpxXGhe7dkfNnOCPVjwn
ExH22v33YvPjtv/r2j+Xt4EakIR7FmgH+01lEn0x1GSEP32yS6H7cz0OLYz01gKgSEXcFSWFyW2g
7rjG+955b/gPWqa27jT8s9RBmQHMMohl4TDJncv6LAATj8BMpiSjTOgCvRxSb2QJEmocprHvi9ZJ
x8OgqooKQDB2vKg4UTovp32joUdbDg5+MPTSL3SdCX93MX9HZBuEmQY2pmfQauSd4aC9QbL9o8e1
phi+ZlmpE7QNN5pQVnSLQ0Q5av6o7fBm1IF5BHTJXepfLMVLoXzPjJF1xy7yAUMH9ohtv8xitgBy
zXN/PJ0GHXaW6y5drJ1xwF96Vbw/A18XxZkCNOnpNeAxakHCetNzScGj1q0MhwdEGTTOfhoIrTlW
zkngMibn/bccNQnn/Qu/WYBSu4KghEa/w9Fqea+nvt35UNQC0T9AXtZRltdQTstwFTy3cHuBIsa3
LQAckj6IxZ/Rmqy9fxuXz6+xFRzpHnQ6qvNv0Ar9aA34OY35A+yjtWoZu7wGStjILt2xQCAVXJXF
eda/f+VLaxKb5Qeqwxa0YukKeJcFjXpIIjC9oXEfF62uG8BwJ9k9IN+omm7X1Zy7L2A9dVtkWosO
vV/rQ5hFq49yEXpR+IulUCr/qAl1OUUhXjAWkiUdWDRNLmETbrsAA/BC834rq8gVXNn1AUnaOkXH
Eg2lx60bVLiujhzkf7JJnWfCP/cFm1YxYBVEzmjWgtW73CRdzcgUdnOfIe6Pju02JkAuB/PrHHW1
QF0KOWfzR565OpxBV7i0ftQ9zAekA2uIMJShI2z/0qMc8C23P0DoXE5lzCGQr8felbalFG8AOhwz
A4D9wHv4mxS3TlSFxQ2vqfJT8iQ/kSQHkFRBSlpLIbnN96eTfA1pon1rOwyU77GUQUS9gTQRCgy6
mjs/pE2VczYPdVv5zUMwBHn4jJqcgVd1Z8zQ+B6XlQm4kZsTpJ/pQGd0AJE79uSsshu11Gb1lwq7
KPsRG2iApw5GONYA1MLvCdHhQs+omZFbRT4Y79GyI/ZhSpt0cgSQLUZ8i97rgj0cXp7paaDpVi2t
ItSowc3j1cIkBwcBQOxvvMa2p9eQkvjIfoSpOe4MHzGPjNimgsOMt1ttxyNtWAjZC/MBldfx7+Is
FrC98RTBbEriPcQ+rxkO1JidFrEGWgaamjlks6aemQjEqogniPu+uMlQ6tEhvN/qmYxRe4xTmCeJ
ZdWVKZ22626bOgatdqAKEpvP7789680cgirEmgOQSyXLIvd8vR1i0hSLkU7hw1YlVuvjE/qREN9y
GJmhDw90zAO6eA1NIQhrKxR7O7jqlZKapb0+xswl08j9RXQaOrhy4LbHRrZlqr6ZEyYB41Vd+274
URPysgcJ7R94B7sHDCRAQpeANQfKOQVgs7knGcRY4Cfc/NhBurwA3v+ycTA3ttxSGpqEAJXzfzg7
rx25kaxbPxEBenObtnypZEpq3RAqtYaeQe+e/v+CERpMVwPdOOdqpgUpM2kiYu+1l6EdVVteOgWS
wfQv9/d9pUXIEr8EubEP25Bb/W4TMWMT+Ih36mGuwnBLvzpeN+DrBq/CNT6F1NkUmgHE6OqbzSbG
C7tMeUTzOSTLjDnXErhYlJEch9HveNA/fi6FbHig+4bhd3pop7/d2FB5i1BWxsZw+edr+Cs9gvoM
poqPrMtHJBZQKr2jrUwr/CVCGPuHYDOGDmIAPof42xsLuFd6+P+qDnA3CxyPTA0Egsi1rXd3jZlJ
S0/uVQ96oKgr+FbV5/gIZDQLrQ/R2f4Xbsb758U25vHIyFOCceb8rT7HvFkSN2byp9I8YLOsaL79
77+/vwwgin4Iol5O3mJrQiR+8883+2/fDyUcF6C9HHVdx3t35TUe8sMaWum9lkbgC8u48PJX1VaF
2yZtZ2ujDP43ltLffgCPGcITyhCUXCZHzF83BB/42MfSoL+DSbfvgO7eZOvDLzEGiazx/lUtCtYu
64Ov/3wD5AX+76lLFg+ccJgLHCxkwL5fxMUyE24Ck/QeS+F0+xyGYx9i4+fHgDz86M7AvNBGLPwv
C9XGS+Td91L6ExEPQVeys96XHoXnYJ5die4eZVHajk+BS17oa1SRDXerh+k1ZhnO1wHTORpX1o1s
d+HLy9Yli+1c4t9tPtK49gFEvY3YQpy560uHHSyboZ7W0wnIU4rZZMU7hBDLpOCeHI7HjohtKfhi
qioZEf98W99XVtBjebEhmcK9o/p/3+TEXtwswrbyezI9nf3UtbMiOGAL0BXteayLyct/a7+8lTHJ
24iIbsKT3gshNP7LQ36/pYTcax4z4YE2W/bfWpG5xPjSGdb8PtjpPFkCGQ3QV1Z2Cgb854v/+9ex
czG9QwgJKZaS7q/vdJ55HjPMzbvDliQAKMttifYqm8bBbf+9wfXemWVwjwEaYd6wkkPPRFDz7it7
fMVa6ZZ9pwnA+a5XXJKq2V7HfpazNqmjn8r7dB1Q0h272u9JPLLHYWvKCyLp2Ozu3QaexPSg0Uot
qPISWOtgK1EHoLqUMSiTZhaJeI6Q2wmUXR+8bRzK+ODzqfJgWOFloIyLVznCauZe9hxUKvLdLf1K
DsfSmNkNIixoHaCCOx+/VBQvb5zkOCvIKjlIJ0iu46+HijEl6lmOIHMYg0CzIi7ByDJVh2JsK5hl
TpWUcVWTTTUaWBj+pwdeKLkiUtJVNvNYxi0jviMyKlhBmRq8TbUhBXpbUMsfirJFwpId2ji+RDcF
Iqk9YMmpGeUlSZeI3xKpPicYAvhXIWmxt8kFJ+Jwo8Dq4lJCh6qjwHuKymBNKh+3tM5wE+zGOjyN
/WtfociJbvOWlFcG6BKcMc155rpzZiSbc/ESJPYf1M3SzYrejnOlMdbAmR4WCBzyt1eNtoBryu7O
3j9WYcOAaxIn3jmoZu2Zay7TrIzVIphLUuZ0JxjakbyZAWkGYAt6FircWXp8ZDvI/L88O90WuATw
uS9koswTGgcQTrI9JIxJmOKMCf6h23AA+TFgG4+ujOiNbDgg1fIQFlUpVwk2mu2va23Z3EBjtKUg
En5Ah5Ujyyry7yq7maP7bAz68XOORwRsA+YL3hadVGmFHKimEDPjqq+Yh2IPkDh4PLouQGGL0v8H
xKcsOA4MXHwsvM1GIuRJhi71dcTOTdovppaRQKaHmDkdfMsD2DwTdYIk58AfgWAORW4SeJDUkiFR
AyngEQyfZPG+bWqqUfrG4DwnhY8u+KRBeA112WpwrmHoeISW+FaRLCRLMyAI96kz2xm31nYbi+3L
3K38Lqclu+RXBYsTuwwyM1PvdeFztldm6+P4EzDDcl8Zik/jM/Y4VWNfDKMx1tfAJWN6eEa9J9j3
ceGXY2PM6LceOmO+kTx06tUcWE8IcBeQ/EskRfu0KcxkpxmAV/Oy0iv7FmVhk+P+fwiYO24XTQZg
N2QvuG5V5HfTSxAWg8HsSSHs7LwSa+nULqALuGj13exrFbpW/qJe69FfWLLFvnAnE4w9OW1TaONr
PA2mfA0VWSE2mHfcNIaNgfRxUswe1aoXiEJ5MRWnMyctyzPhYuJrsWGxHHvMCFDVyfmFVnT5eTEn
mCq3lUc2jF+mSYpQtIuJeCqIcYDopfmcpAJz2OorVa9YuPrIwMySWTZSr8XZ8H5RaKpa6gU5E8bX
yesm5xyprUvP/khMr+X2t5Mzh53Hau56S32btGdAR8YyixZTX6neVlMToF5wCQ3cl6HJTqypqy7s
YVB87GwS83UZqC6YnWnXgyRph09NZQfpWeAHWQHhqyGHmlD54SKhznHeSh4gaI28Q9uCzgJ2Ancm
Io9jn6Jttkna3L2rJh0VvtT8s4gBBn9f0gTbN230M8xMdr1TB8+JDX7dX9MAqJ09LbXkkKUlLj19
9DJBLgWx2/tGmdVxyCZaLcJjMRYC98X8WGPzm7mHyHBhqbRqsc3q8/ZpR+esa/gFjzCe7iHO11h4
ByTTMuxMY2rq0fx+t/ddr+cusMkHcOO5ZWqnRKjBz8PjWtKROGTlKZAPpFgzOdt3ek0qUBQZt+5k
95MscjI8jf5+uCnoSM/anb0H1NuDAhnH3JJL0MUqgufqK2pIB/bLe1m3fVyWyRH7S55p1BoyyAoW
R4ewuzY6qYmxGMJzv9UmjhbapUrH6UC2kKnq5X9rL3cL9P++bLsAaF63nnU/1YX8+44CLrCNkzeg
VhVlUpq8W/oBmeYiQQ+b+K8t+5iTsQZXSB9zbjBQ02AVLc81jf0UYtjhcoWrr5sjX43JTRgAPTqU
GQyrCmVRNKh9pbFKmHyXUU6gjTOcRM8UsBwGOeukTmeg962JR4nVE1WPtumk/8tSAP6ivl3VbvCJ
ZOOgAfyCUon3qGBD5eLwsmaPRJMqCUWBUufQcVbWY26Eq/nQ+vuorRma8HuHuir9mjBcrg8jMInx
q5SRS0ppXWLIyVPQQ8mGmQUHooa0ZzehnJR2DtA38lE6A0zkz7BpK/lVxISORAEPIR5AXZxEOINe
DB8OoDi6isLeu1iAATY1szxPwIzdMjzK1L2kPvkAgBhejibRLtF5UMR19dpGyodAVwL6uMcwiR3g
NmvtESYgPnFbHR2TVqAuZ2RaOSRqkI8hny9PiB+uN2RdOOoXHTBAYvbFKklQej5bdxzcL7pDLL1q
lbNjRUuKDEwNkGPhOs1+qGvcURVVmuOFREfSjaI5kVsmmkP5xjAxY915te1RaOHhJ/dZJx9GXhio
MenyaWD+PIgTicOy++kUpye26eYE+QkMPrHHcJIqPWnuCSQwWVW6+hOpD/lETnSJjVYpRqCIbRQ3
rGknuo5QsXhMjgJ+Vc+Mmq9R51FkRxC1DDjBDGDU7qSKp06Vh7BD5G6hJ7+JmrNj3YR3qZr86tdz
y3aOYztLiwVVkCqgqleVLbxjH/e8KbUqG1YdjCTuJJs8uNdtXnFdEC+MULoCqbd5TKCFwj1Ray6X
BOf2wGjDgdvZ9XDHgttwwC44w6g49t23Sj1skrdZCgNW4dLJIIVj+OL4phy4O1OS9JjaJlPtCTQJ
UvCPCaOkg9ECSMKBYvQY+Q7Se2okDUJTlRAJuac2JiMu1fRRz+DX3isnuHMx+q/0OPaunPhosUuu
SHMW5QXPH294Etg+mDi/onuvMkYJMN4KGLVMdvfdWq8xaPNbN57CMNtKn0CD3cfBSOahsI4JxhSp
f2jzaUeyOCWL+jhMbEbzcTUZ5DKlV6RGhwRGtnS+hw84BGtSlgP71E4c0NVrseAaXtxbHMm8Ofom
awkiJzR62KOkm6XLU68oRAhS6yE804QsglixrEz6/I9/7iffYxSYH2LviYgNS0T8bN5jFJvnLyJL
6vKuKomieYSIrer5Tc6LVzXJ0jKT/6cvRilECw88A+zvMbx6D8WRVzK00ov6Li/TltBzOoUAkn+D
AwtOFK2xVPW55qhgm//nL34/DAHip6ENXeZmTD2ISX4nWTKMEDPMCotxEhmb0L0FWB0IfiKsLobC
DcVhDEKyA93OgkezjWlf1sSqrg5uNj5nameTDCa3lsHEeaR4hhE4zs2Hf/6R7ye5jG/DEBCb0JOI
/wuE9Nc+f4XtEgTN5Fw1WVDRERdtF9flEvI1w6UpjQu2M00a5CRMhEH4aRmmpmmuosTkLcPLvgPK
70RmEPgJaQ6u8aHiNXDwiVQ+fW1alSW+Q7gXE386el1J7ENKpeqk5wo7F3BctVq8fSrwz5dp7fDn
/2BkzM4tmbpukavOo/hb5LkJA453c7IvJIxtRkjplNQunnlRZLXY2A1YGrQ4TWXU/oR8RUtMymxE
IN6zrXzkfIeKm/4x6CzjzRrZVDCm2gcq2hZP87HBN6HgHqoAHnh6MvEBwSs8Tcl2fuySYF5xkw9S
aTNvDqbUfdRzOQZ4guB2Q2c3j0OKRSGdy8pG2O4uddCn5ODcnZoJgWGEgsHmcJdnxJv2BRJlU5Ob
Ccdus6Zrg6VOnzHT6b3mUVAGFtUV0Le3f2AwCnfhvJKVGrwW5Hsisg1cY+wL3L3x2naJzompq6/b
iMfBE2ystaKBganTlIfaw/c/v5YroSyPluy64d16kTETDxYTkLY+rV0fOg1y6EyiBp5BOg002gnD
0/XW7NG+LSdnjjOjOOtay+v7cDG+riv2QYJAsA5nVjKaS2F8dmfTJKiXjq9by0uB/40dXDOc8dnr
5xUxAELrbVjLBBf/vmcssHMMKjVRiVE6BT+x20nza0IL0gLaFTXivFPXDjOv3aaMOPU0bYbjnKP0
NlbW8Gla+oAghcFZ6eQJxOlgfd5W2BaN3Wd4QxvSKLONMLN4oTPMsxa3JBHIcGsa7OLHmC6z+Ub1
a4e3Y9NZFpEMpDIR49tAeWBypt07VdOUhenIA+mKeFyLhylspH2S0ipoS1NdC0i7ccoE1bdNG9G/
5WEoiA6nREUINBJnZMweVv82Fd70p1pIxOow70sDf0Zm4K+4nnWn2RGE5HV5aOSv/7LEsIH4Kx4M
BgwIzNaODbULZeD9YAzJHhlsVuPdTiLNiJuCyZqI/LMFrRJfTHbC+CbAH8djulmKuoy6Bt8OOw5u
yMgZ29Nikdt+z9Qwtk4N9kgP8zw0YHOjlXwuyaUkt9QlI+vRDqq+J2rB9e9M7sHIYua8JEQDsis4
XnEso4HQ5ZEwoDG9VnZhiOe8wFbnzmhwvbqOyCKyUyqy6UfcF2t+cbyMaHSqqO4jNgiZDCEazPLY
baG3og3w7fnWh8NJDK8TR82pjZNgOGbDAiH1ZA3FYt1HUd08GcEaTMSrodo5jFU6n2a6QeK50rA5
gc6I6C7xUNTgqVMHD5gG1NGZiK0m5GKL4FNZj9YjwTLTjDLFsb9bfpTdlYvXk6c1BvlTV0XjqRsy
63WpluRQDN0PP03bV8Oyi6fSNRaShUj8GPoD08KYaIXaSTEmfQCuYhZ+Wjwiw6Nj7nRVbz6gwTH+
jKbEIYM+r04rYogzvObkGHh9eMO1WmfTSNmDBPjHZx9TlUMPAQSjrmh7GLbYTQ5RGaxfCC/YLkz1
XXEk0aV/nrK2+RA7TfeYoLu5FOvgfRxCw7nGkSnOIm+kkyHgwT3DvPpq0jmcLLBbaS0TPOI8lNwQ
cjV8NhvP+2O1w/RL3A/dy8p0/iHBfuy27LuhOMBCdE8iExb10ryd/SV3YT1t+XJrOsN4L+BCPRNe
ZZ23uctJkCEn0y5IuSMpyFr/bMK5+NSO7vyhInnhDpOy9GkOzKqAm5S3ZxK8t3sUVdEnXLfKOyuJ
vQ8h7Gj3kOPmeoAtHt6bkF+/lN7YfYmwtbvCuDGO4CTxjdeNDacJoNsRuMhwAU1D4kYmv/7UDHMt
jpKDf3HWyfiRkKLzEIkGxIOm8RPMbBuafedc50DYj7aTGKd5m7ZfRReLt8TP8OZZY+NEVlsHKBVb
bxYOajckjRQ3Tuatz5ttDI8EoDZXK52m23TOkTER5wWfPAvzY0ZI3AecisPljM9xzbeQgGLQu943
jbse8jDsgktYFvF/YBq/Rr4Y3yyOtys8xehQYPSAyMtjP8wK87PLBnw2liJ89pKAiLgtE9iT9VwA
sLD3mWxNLCqNGZ3tSYSi/jFWuZcdUEaLB15N2oSomVkndo24C1My6ovCekgwmPmxZK4BtZ54yJh2
59ZjO3kRIkNCip/Wq8Os5yC2Kf+R1kVWHme7hj3vkagaN7GFqBkrOFjCk4MOdS7rNzbUyjnY/E9+
4OApwJaQ5JHja7TfViMYLx6a1dtibEb2jHQrXrAoHF5mDhum8X19HbG5OoTA0J98yJZkkFbCIt3e
yKaUDhn8fJkupDb0f1jBUD+lFGtnY2bqfIqnwMwOCdDcGf3n65zjB7iMJDhu9nCLo/3PqXdefXB/
vL+L5WKMQXHcIru90Pg0xq017DFyblzdcGGlc6Q8ap6oKNLowmgznuAC2BzJqQG+g3StYXutQe4P
DKvMHzAoluMceUQEuI3xh5EMNu1gl5G2za8q/yTpy7vJU8O9F9vafke2ZtwVtDQsLnd5TFxnvhuz
Pofx4XvVCWeL9o+Zs+PeWj3/CzZ17Qs5FaZ7qtNiuPjr7L8SNFJ1p5iAmTvCbgLc+imIfxlpla5w
IpsBfw8bI7Fz6vXZY7s4pG46cd+cmsKTGdwBquPwG0P78Gj33Yo5IHf4bpwq+2SKGWr65vcfic0y
ziOZZNkFFMP8mDAJmA51WMVckGAvgcz7ETm+8WLhAfdLOCvbT5Q5D2hRcnLS7MG8m/FDO4fOWH1G
ngnKtmzhj9gRyZcCSkN/EJKicuAuNJ+sKPcu+WLhyp7FXXlNRJh9d/2xvwmMNX1ze/gDbjwEOKLM
dIf+ZhOvF9cxSxPJ7QWDv/Yus7P6hMkWKBgBzKc8a7I/wyZtjxS+4UsHkoY9nJvclOFGRO/UDwhr
7OS+2qbmvs3WJ374z7z3q5/tZtUMP3EJFIXD3t06wxl6bsa/YkZ3V7hD9IRoyT2vmdddnHZOqoM3
Zw051ob34DaLfwga8zveOu79UixoAEuHXJvIkpR31u6J2Lzy2+baKd7fnujh3gzRTeNO3WcfDyKc
1IoieyKYiaiSnATqulumGz8yiBtlN7vO6xrfuHx3fgom1/iYhtOEuR+4Z3lZ8iKrr0USpvkvxa4H
JZSM4i0LcYooyFCjl822VgJxSjLWbBRq2THDYZwq0o4SonSedbuonCUU6qFtRzSrrZ8lP+mjZrIX
bCj0cwr2DIciBThEl4dB6nnA/a8kALZM5i17lYln1LE5GRD8FU95WlFcyaZUzfM2/GLG+mA2I8Kp
AyAC87klG5L2a+xF1UKm7j78i7YaagdlP6q026j2apKWFPbK6AIr0GNf4Wp7Wsdp2h5h1yTdTRcz
3sCdKmnW5sCq8+unvBqHaTwkEenr5xEzv/Rs9J3TnQyjBtAw4noNf5lYrsZ3WNZbFSKmghLPIN9g
vrSM3+sXd27j/NvgJWJosC/pRfYRM8/YsgBmi9I27xn6Lp5/xf4gIVRuxFIWs+MZA/31PMBwDLG8
aQtxwPghQacVzzkH1wHzDSChqV+YuOkJZx6RhwOZj0rnpBCjaHdCa7etWSMYL1k1/MJwuBghSCJI
8P78bUJnNyGJjcyXkzvCu1liIelZ17ggO7IEdys2/wcFGZFtYz6PxhVeS1F/0K781cZoXPA4EmaD
akoSQYAL6UFSbmOQTlb/H3pWSbMx11m2C4tHZDkCziZDe/ykSuPMNCSMpscLsPqRg5J8zC7woi3k
tKIrit3S98+xw+HXPVFLgZbPWsykBifOSNhbTki10a/JFYevhu9Ug0VitxnPKnxQDkHwr9pnJZor
DA1J8ld5zyVFDO44MzI9kkjVn+lxjBZeidmWnuSpOcuBsGKeqz5CyyGU0HVSQrA2qyXERhckoWtz
3rm6gdLA6BmS+jWFE/Jsa0Vc1uihnuxMlpycIRiN61JuPuFi3abB5E3GLbM+J8P9JuDWiCvd99rZ
z/EkOvGfIfKDLr+nL0aKdpiYAJvN3Ua88jIdbYSgDSoWfOhZ5CqzosaqvYdhSGiV1EuFgrE4MkfT
laOLOICBAmgdkwG7HDp7gpGB43mBJJSs7101IloCEok+SWfgXj0CVXidb4bcdC0hHOwqZSSf2HQH
wznMsHD8hYE7WYCHIA5rL+Dt8SW8uDNnJRMhDW9p1rEaPQgSQ7AlIGUK45WrJbpxxWhfIa2ta5NN
f+4CY7KxxdvR40kpfQky3mBDG6IAvj3UDjURej0lgNEgsqPmMLVo5AzqN4dXPabfsCzDagDUKhYb
I6kpJXQpuI0pWEoyjgu3Af/TqGOws9S1lJbOQsKG/pJaS36tZvTW1D4xCWlUg9hC8lNcG70Xsrya
USBz7t5gAIa2VL6OrWQ/vK3KwXDcGJgIFEVzmlTScKZ1v2AFKH0jB/gzZnrMcjoH1GbeEo4YN+6C
Oz2H1qI/v50mepTFjVKzOZT4qi2vC75g/ZuWcYooQzGsmRU9qFTGr5j7du0xPNn5CFG2RusJ58d1
+Z6zLZifTRx8G3bnKM2rC9LSafpO15b9qKXL8My8PLKKj2ZajlgOLw4pW6C8be6+pluSlw+Zj7n7
paMf81/UXjL4TPYZqO24+pBUaA4MD9FoemB++18kXS06PWbUQoxJyeKqKZN31C4HNgotdNaS5Wln
iZPQxCtZN4RPw86IIjRtkCUqH1MexTvuWLXe9zlYrOinSCml3wpvkI1+p6hretHu4giFAvWxKVkd
SO7lIGhoEKl/rFYRVz8aG4uykajBkcTJw+piqJwd1X6krYgUxwYLY/lzELBP23WtQhgxcVC7Df3g
7uvURDOkD3WLuqIg6hywPiQQm6IPCdk3NRm1epFwp1zlDb/tNpFqfqBObLIp5dCyXlx52tvhrpB3
AFT4wzk25dRI8ZnUHq2P+ZVI55cmKlbnV+/B26iQeZMM8KK1yyiDJM9FjYHsNZCBAiXOrPZySiBX
e5/VVoYxsVTW6Wm4mjsTcy3vq4k9IvSCWfH2q6GXf3HcRx0xoT2wupTYHtxL/kRrWeVKbSbc5cZn
bb7TVQhmBMjozu8E+JGaQfWaAJvJ40e0jbx4ZUVM4oE8frRmQ9T2IhiGTHa1kHiiNmIfugCrHYmw
pP3At5fKmGzCiiM9RbCaeVzqfRnU2C3PZklecAjf2l79acXL/nZZGXfhBloAAFfU86LI/eCsp17t
kiO2uJ1ktiVjUk5dfp6aoK5NJHVENWQA0R6sUmTs9Fo3oHwYf/usrrGc606oaDnIZkW0UM9Ni6D0
w1bCPoHZPZ/bdoncbvw5lsdzphQVgQj2gcA+gcQ9YWTHqzH5M7CjR9AaUfzu1g7dbubgbsU0djdx
VvfOeMY0RiaSAn+GbXe1etKumEdHPrHsV9OvePmvuHeR/H60AtCc6a6oUqk6nLAWhWI/wkjATuhQ
OCUq3hs9E9P0YMft5DwHXrSsSpHoO2lzLOuyGX72pSVG+5PTuZWbnTxzWoP5YlmrtAAzsYbkzqgZ
upgiqQX5zaGjgJfT85Ly8cXfjxyj7OVBq1wbEhpQKYncedZa00hJLD8VN0J5AzFHkBVAs0/DYmiI
3CtTuWWqw4spmY982pF6WgaJyrRvEltNqreBcYdobuBzYCZ3J3D25adtOyXOHcxNap0rBs/laTJo
KU/QDshgeiITg9b0lDjpEhQnnYugtVxRiG+F/SXH66iMoN3uK1m/xmpB1+k0OPFjkhnLBieI9AfR
fu8tuFRnQRjMtJ4Yn7tcha50SCqWzz+rjMAZ3kg82V+vncSQJELwahcRVKPq7Ad9xr0y3U7uulrD
rI0AlCYuU1U49iiSkKVvYNHlkirnzaUkCImxkys0j1M5WMuWQB6zTbe7gPZMT7iFnZFjlYMTZZ/D
D8QDidcl3U12RzeakVtrmoSeQ2uaEINPOXDXij3t/qAN34we31HkSsrrVPNyGpQDPGbHNWldXooC
yyrnSVD0EY5X5ygjEAVzBPPvElFt2G2RmTsC0S9kEsjSwIwTBn4DhEluUe1jyESAyUB1hFvbgtTY
OG4FpC4QZ1iJFTFTexmtqYWIPEkTup0MJwv6029HO8KweBKWipdqKVr4YUomo07EKUJ45d0byC74
BVo07fWVHFavZAExh8xXt7C7H0Xh7X4DqrQFhOl4gIqRKbq15yXT70xHOjkbA2QeaXczxB3u+Vci
05kxXDPkWbs4vKYcoyqTy0aRyEKiarlOfV+x/pYrBXKBXIZLPMjVa85sJ94h6rHxME9L18xVdVRn
GyeB5FqsgJHzOXDMrRbQFp0cX1T9zujOA7P/vQHpcYG81dt+puwwNcmSXAkptNVt0oqNb08QNeJi
5h+qI01EL/lpQ54O3DN1yOs1TR6cunZ64vzSKsO91QqIn+GMi3F9uShXAL1hG0pvzsVL/wCdHlYp
EoJm6wSK3hCujtx19YzVXYn16ZDN8okYgOzWkWhs5ZGjt2yYSHJvH0083KBwKlF4mWNr4p2UrySE
Bre5QrpyZuu22atvzQ40GofkpPs0s9j5ziOOZVyMutHqlYtgKHKP1B/ZihakPF9spbf//TQVczLp
evnwTXcBbzpAAKeE2nqcI5Dfj1KIigk9R/UKijca/mHdIpibHOypXxNWy2QLGB/IycR0TNFo1XNw
hlA+dMVt6sJEangVuzpRJbc+yCN6J74qUhYM+r+AD+Qj0hwtyLPygLZ6Lw2JXCAR2cPaQi2Ktkc5
lV9+W4QrBgdGPvJ1rZUoPlX03w43dSooeJsG3/ebRad+8tAsQACacKlohCnGODwizfVSFB5SDuSr
rs4BXwEaYJR7pte2ScJS77Ty3pvrIu0i5M2UhBWlDodHKLfaCJkD9zuxhezEdIjdZJHfXtzg9yW9
NbYOUwXsVYE3sBCexkU+jJUtmg8TINh8ijYj114SuundPNgS/AjltT8qtf1I0AifKds1+Vv2GkZX
ixPhu3yyNPWFGDfEc9JDuVEka/oveC0EysjNf9grNgXaJE4Ignn0QAcDYhc4bng2NKPSf0DbG1QG
ry2uCrsv57zYksmjil19dJPNSZXpKv1Wm5IfRRmmiKVwyanuW1ANXhh/h0YUD1GbqKgqqt/ZwZWq
9BOX6GIcjdROUeTj1ICNUt7Exp2lYrwwvqP/0cwYfS4watvRMvWu63tnpM4i97YdbtErTtWaC5QQ
rkPbNWg2CIwPSV1V5VOMtrp9g2ZOyx+wkcnHq+AuM2t2mEz5gOgcALMpppoCr+iNrcdwNB2LJ6xq
zG0+tuYSWVQ9sp0ReScJa6rUZqYgaTda+eZsYbNKWy4TCyKov/I0RdIty1gLers8mRQ+5zm5rImL
2OI1VxxFDvJV+jonZDK9ap8NbesAL1Tu76oVCNUur281Ogp5nKegWDz1wN/J/MESp/byGAIn+u7R
VwmWlk0t7520SY5mRGqKqN6AiDqQdYnCv1QDZCwQBx7JuLE8MOLRmUWoD5Gqt6US+bcrxf+GLUBa
2xedIiXCM5K3qHcKBJg18z1oq/UZG3Ep4f6t01VEInoxWevrBl+qovkrv3k+io/IMqVLVK+DhjCJ
c1yxkSImAA1rtXPeNOTSJPkQ2EQTLOYl9Ukj9w6av6deZGUmTZDbwM3DgEk+E6UGpE70oMw7BlHd
aqV0KK77x4rtW6BBmar1uWxxdg8PirG6dZ0kz2q5jz4dVR6MDkjQpm1ZS5tineExbt10ZzUVtcoF
tVs3kYhjJJL2qfe9YBaSY6idqlplUfab17rXaAl6S1a5xlMETZ0sK7tJLlXdKjn+LMsGoYJg9Gal
7ay01qFWlZvwQukIlkJuoaCyzUH6X5DL5YQ9BympYM0VyoL8RRitSXmB5YXpsOCkEhdgTPrX9lGG
FvtZ02WZLMsLSvx1Mbsr3v6htZ7A6KSvdgmViHWpWL2+bP65fcpgi9gt3jqwMR41Ge0WV8Uilpkb
ilyvYAHN1lSLKMiB/mlKW1eWGZ3pS4MfNPbyU4OqZrxz0jTntmUr46Dud5GN1q2Bl25crkeEOlem
C5NJWcVsqpKChCtJxNIeRH6mGY78g16VNVp+YZAcGjARG3I8i49KFhJvOG/ZN7M3BJSOupfUnHJV
H1h7iz+O0AmTc9pa7lB8YruThTmey/KGh6YrH6m1MhgBDCVENIxheQSoZPU+npaIc/iLA9I9UAll
XaC13a4ri+imIIVOkKeeyM1d09D1oggSfPzeIjBdVp8mPMfKWKNX8qeuTteAlVk4PXi5BiCUi5bm
l0dLn4znKhzQ/DF32ktRDTlr1r0U5/IIU1X1hcq5ZlbgYa1Il9pBYEa94JpHMdf9Or0aKSAvHWVY
W9Zyt1nEuhA24VfluD020P4X7wm5GNZzEivd4qZMfy2dSQ11CYrazj8OBewa/5ra/uSFSJysZCRm
KMBS+eCBIo/jMfeHtf2V2I2YlhMKxq14otW2ypPfEDE8fu2xK3HDk43gBTtZb9uc4NzEgEPXbQoa
/yTRKOuxz7H1up9aSFHpNSrpxD+s6TQ6t/Vai/K15jX6j2cw1n0t/TGaLnjtbsw182r1geOhTt2J
uR2/mU3biSdUcXF1jSd+HywqB0a3YN3h+OWdMUFwr2B+6fhh6Xi3LpUdr+a1Eea83du4wpwKkdsw
6oUdUBckbL/QTdxIrIcBlfd4MucF/pfTp/Nd502+AKmhv7Me6q2uZwReTe5fMLeJcP+xt1nch1m5
md3F7aNhYFgSkn+WXdxyNshiyoQxPhpBsZTrEW4ujP5DxghwMQ5eHc+FQ86ZWTsB01oDj8DjuHXz
CtUpzPuJUDKIZe5yFBlJP/khI1cK/nbK/uCfTJaBg6DeNb2HGJqxLQ5GWkxBdIdTVDb4B2eyzGU7
Tcys5udS+FX3Q3g1rJZoSr35HhXpKC4Y+do1SXSleZNhR4GzM2qX54Yo3ea2BfF0H6OyF8a9J/DB
/BmyKTc/G9P3czBQA43692qD71Sc03GZ3OnQQzNvQIZxO3jzy5mZEwbkX5GhML46eNpya2c384pI
Sr3HwZ0OYI3+lh3mMXDEd2+jvJIStwW0TYfmKOAwsJLEeIAZY/sfIMlwZw6dG63CIZ+iYBaF1T9D
qGytPPcmkW6n66FCTYp7g9qWDUgs7Kua/K0LZVXiKxVChnRj+hqCtNMcqBJJJFISeFX2M7aKVlK+
7IpNvaBeLx4VnVh9SK7ml+x+E4ez+hTL2gOjyVRiqqNnGXnlzCErjHUQrydFUtYHjoI81Yg0xvlp
35vx1+JlDWDSm8dRAGXD/8f6hKAYe9u8L/HUdmb4vLhbbYTnYrAYXmRZIFukzYLp96snJUpAI94L
0f/2bLI4WqyW3a1HeyE+D00Y12/ZUPjxnzMJ8QgkzcmsXoZycPGV2Meb6mpXjTvtf6TY9dk6ZyDM
XmkONsOgvnwNOMnWswBdHENsHo1kcU7Y0kp8olAeOdlelSRcpA2Hg2zqrH7wxrwJr+syQM2MTZvE
vefWGpMSnS/TaNJwRo92oiee2Jp7SgrUt8++U8fbt5HCg0wyHyLldEQZBl5wdoYCZcgPu7Rzy7iK
vsxwh/sY9Hx80N5A9bGi6T7tRrY/Ay3lmooIM+wsSwitPLbNhDv1Uplecx67tmsPkKZsAykbcaRP
zRK1kJ/WOckpAbywuGB81V28YU7LazSs0JPwAwgiiOup/akwjdZ86lFYnSavXRgZleUfBeLVV8y7
ixthh+NPDp+hOQWbuZ7jyIvR7qwpX1oG6XAPiIjjfTc1868pA4O7oa8TH1NQzKcqn5y7MJ+m8zhH
LMQBfNn9syG9uD71BFN213Qql5+dC6XsEG72nB3nfmze2qTBn2WFA3RC1R186hAr3+OD6j5g4uHU
h23O0/Vie1X75HtL/gZdvH1mdyt5yrmbAspVzpe06YybIGafRzG6Tjd2ac1osWmyze/QotnVykYM
X6nlk7ueh192h1iMTnBK4Hre2qDff6K8WO4wY01hfXQRehVGENy8ountN0YQhfdo0+bVmH/PuXVM
GWi3h67LQMgtf/KvSUCld8gYa/m3nrdlBSKXMMkhg9n921ZXMJAS23dwS2N+B4+ixIRktRFi2bnZ
PhKdwLS4Dkq7OOU0SMztWnEbVJlzyi1nfsjjxPoWmiL4jutQ9jNLi/EO5qPzPC8Wb1nkx5eosU34
S6V7Z899ER4HcPvlYJtxd4fVhviDs42TYUK09IdhufUlTVh3tHpfRpj332L6IdKo5/xDbUbVZbCH
6Op55nJxcN3/bld2+hpnnn/0oiK7zMYW/x9757Ect7Kl61fp2HPowiRcR58eAChH7ySRmiAokYTN
hLdPfz9o63RLjHO1ew9vREdIA4msQhVM5lr/+s1dmsPdcSezZBI7mHOIpUtzpYTFkppp6RjBsJPN
wZJu9jJXmnHfeV0674pRb7/BfZ3dCGYjAKBItbEO6iJhZYlxsQybFh0k2Ut4Z5VaUV95/dx2O30w
pYxGX1kQTfVsPCATn55zn14sUkmnh6aIR4ghszjPMWa+tNnjz9dkgDeYLva9oZpyP+QxwfE49Z+w
u0vgRPbTFJ/gbg7JjnWpuveGJbnA7LXzdjUV3O2UZNOLWfcJ3dvoMZG38rprI76IdW9tqac3+kws
EZPo3NPDGkfkSw6LaDWJ130z9vJbqWEx/ZB7I4nfvGLvbfOBt4w981lpuoqPujY6w0d/gcxkX3rT
7KIopP1efefB9rhCcxFuv5IlBwzUIfRCWGeAishJG1JzAK+pYsParQtQMDrLXs7X6KGK/tKckJCc
oOfUxgkcrTC+Lgs5BHno+ZNnf0rQWeRD4Bo8bawtJpBxH83EZ8trXTclbkkwRrHsl1GxaI6/WkgA
idDLrzMCAWAS9XQ01INnmP+wv5ftMkVSxYN7Oeu5ziS60nX9YloSRrtqRMd6MJdsvamwHnEDvbC7
myz30bgTY2CmfgtBEUpakOsM2I8LcrqKLAlmRRFZJz2CmSFp9BO3QWnd5ENpr38ZZ/grTxhHFVw6
LOAFF5IKkdfv3FEwIVkMGybX0fouWfzRIPbscD/iQP/Pt/nfk9fqR8pG95//wb+/VTW4UJL27/75
nw+V5M9/bK/5r9/59RX/eZl9a6sOZsJvf+vwWl09y9fu/S/98s4c/ceni57751/+sVN91i+3w2u7
3L2SitB//xR8j+03/6c//LfX7+/ysNSv//jjG5HX/fZuSVapP3786PTyjz88vCz+K4xke/sfP9s+
/z/+OKTPCqOgP9/pn7/++tz1//jD+ABkyLKom+QcYrykoweBKMhPNOuDiXTHwOcFMQumEAI7EFW1
fcqreNkWIcddhv0JoBSv6iq0Cv/4Q3zAmsQzdYpL3k3A7v7jn1/7l8v335fz39Qgb6pM9R2vfpcA
ijibkDD+YnpGWgsD43fmS3ZRYwvmP6c1QwgGPjrcVYeZHm4KVqZ9bBtTu6j8Ms3D0UkmA2UoQRfB
4jd2EmA7Wp9katlTZNvGqIdjhigiZrxoHwTJNumZolToTk3TZgR/WDIbr2PZ2ARPY6ddI5vPBxgM
Vp/l6pwp8Vxc8MRBosKcuxjPY1TfWVQ7Q4/Ur6r8cPBrtdkO57l+KjEYBNkEJQ7hk+b9A9HIxi2+
wOz3jet/24qw5ALsAHd1v7KGfO96mXzCM7TbtjAIpudmChp7XFkS7eeS+a5+tTarWR89JjBd4JAV
XNPTWEMV5qYxvnnEWDU7P89G/QQjurOOQ5zOFBrEofkBAKSnHYEp7MOGg4wRJBtxQIM+DlBWXXau
plRtd8y7VKGEKcvaDGpjgIlrJqNzMWeT1QX2GNuvylA0C+jBzUArGTGEAHUNWKpOhYq8TpjB2hn1
GRAVRGIPo+PqaBcNhJlxSJsvq5PJZz3HfBXDsIZtPdbosbDalHc+bJuW5pzIVpoxUXwEIMxfRSLZ
gjR405e17slbxEtDjQW9LggS1+20vaBM0pp9opb4dWhidDFl52gftRgTDt7NQ6rhT3rLHWOWrn1I
qyaz6V+olzTHINVVxT4Z1E4P8ChyEbPPVLl7rxs5pHs9wysqihMI3qFfmSM8Rle68XFcCEIILDp9
6qFOiUAkov3ak9fcE+Ui6x4eo1Y8LWslv9Quu3UAh1PXAmieVsj8bN4ymyl/Apm0KXgKnvN7BcZz
ipnsLRFBMWKIskJp19SaqxbOWZbqFBN5jml9kkE+1dMsPRW1yPB+A4xPAmLbOHtGqmF6j73eWKIp
I+yFASDJmGHiDenNuvr5V2vMsu6Eeab7Onq+WEMsb/uvTryox9aC8EqOGkTeaNLTuNjNaTOd10gC
vkpylq1dr7LqVode7oZ04dnr4NTOlYUCvcSlW851aEpSjqJl9NoxIq9Yvmj9lm7OpNzsuBg4toWW
NbkfXTJIiOyCBZuGRBj3Fe1nb3wubQKDKmocsDtDzCpkzDpQ6cVDcV+3nT2SHe/AHbSG+Bwko/sK
GIvpRFKI+FHPk8khNsRZVky76wweQd9abwwJcxV4eoo3GDM/CsIZv9UcinuOWGTSs/Yl88G7AxhS
pIl0Sxlv+Hffuxg1dEkdGM6QvLV6oZWINk1I9sMquaCZ3jUXMUQl/UBBv6bAAAXxkV1TxVwSomsX
5kemz+PWju39FifZB7gFmd4+HgVk8aZ3+mIH+TFGY+BnL0R/OkjARDFV+5bVoQyLlgzeFiilCyaI
mmeGmNRbnGTUYRqgzkvsMq68x59metu4U28pBpSb8EmrWO8YMKMgVR5VLZjzoz1MYxXCgPM+tVk7
2ruJaKYvws6rG6dq55QuwMjf8PMCiI1X039enF5BiUXDAwLiCh+lQZy8brr4+S6GZlQHZIeimYE+
IM9ko68r/FUQj1jjspxMnB0YlmLKjlsMmrEvq2ZrtzXWLMunBFfbR0ReJLGvY+uEUglWbxQODmIJ
N5mssO/9NDuU/kwmvZK10971BKEvT+UYF80ZVqGw4TQ/zggDdkdK5qqykLyDUnx2YxNjZcsddHev
lbH3BirLl1NDvwl7+tW6pKfWyIGAo/PVMCdP7ROHMI3Ab6f22kC+RIisnxM7ktYFqTNja8ESt1LW
NGTGLsTlinHdsmj9DWp+DFpcXKPBcGz6QEIS4d/gR1h487HbWriom13KzGqOUcv0TXINnQfOuzXH
7Z3SysUN1raxVwiCWiWhZJTits7V7AcjhpTEwfXwXAMyZJQbZZ5O2gs0FJPnZaJUD3NAWApft/DB
AbtCQMA1kqvSjun7uO7VxeB4XcatJJsXNgMX42hQQ8nZyuE1gx8WHd6Dyl73tiGWYVfDISL+s3bx
TAFFT53I16qYJ9pCQB2UBsjeI9hbwyqJhLC/JC5jSk8J9+d06upq5XGroHCHRYPFd0QSkPjUxJpJ
S51PZnE+iWX8DEnLGsJ01EtvXxDXXQalXuffEFskaHtik8ftYoznDslTIXPMVGWVMejDFnS9JRks
R17CBtNECKP7z1gGz9NB+tU6JQGZctocMDUnS8AiM+EiYdYpAjKO0i+5RHTHN6jN26SflrfZKyQz
jlQ2Tky/1sgvcAOB8gHVhiuFKU3xOPOxrIfS0NaCu0K3rUjZ8wDKgVf3a1PPBC1McKozlEi3zuqu
5AmhxusinrUL+Vn1loCarIzhoXMXFhWLWyK7aFlz68gvG3wp4t6L8eQ01vkNvQcfXeQTTJmtpUQr
S4HlnzyoJyWp5HH6udKTkoT5HA5wqn1xvUXd4Azu1scmL9v7mMQd7UKrjW3Jg9j62CTTvFbhQtaM
b0VG3A3TW86o8sm3GvtFEgeDHKgRzkWCc4BOboqfITAVbWz8aaj2t6rx/1mpfV2/qvu+fX3tL5/r
/w/q7a0W/n/X22H6/PJzub399p/ltml9wOKSWHfbhiZLmYxT7J/ltmF9EK5DFW4wrqQW/+9im9cI
NOq8DKml4Thbif6j2HY/CILoHJ//8x2qeM/5W8X2u9DNzSLXtsGqeFP87zB+fqdgh288iMZwzgat
wH+VmLhYTqeWlKSarK/UIN7alJoelF4viweL8KbbLAbVXXFIJU4wbgpUmsXqP/hGAkCLr1rtgB9Z
S3G+DmrWzyuVN3emCy8BfQuUrH0uGjsOyhXXzIXGVWb1vmuV2X5MjcHvCS9kKIpoCkUPCHCNnLJm
OSCiYAnhUVE05DCvuhP2s8Rj5tbaatFMXPBREB2HCLBsip4AMzFlQYou7Qb72vZA989yMAv90GUw
UQ+ThrzaTBDhD0ItkVM0MjAkj9zV3GpKvxLk5cawcZWpXyhHKx7XsfLlsSh7w3n0VJk+J329YvXZ
03jojTJvHFN0O39p/aq9qtkhoraMPw5Mj2ovgKBAHYMMB7+ezxZvERUojKy7aZAreoMCcdZj2zq4
6ocwsu5yCViyDWEt2CCh6oemvAClkjbbQCKta9WmXnoHdXRA88XETdUvM8KcV3R2+pY3gCvzDE1M
ieSeXB3EmbbWCvVEYFG17BcYKtjwztOLoXuGtUZFW32FSLW89eUiGqRRIHj2DrGQcy3YsI9dDNEo
cJjKZHvI8MOlh9tdfo34nhoF13TzmriIWCNVLtXgPiTKWD56jGReaVCK+raMnbRlt+wn1yP2IKkf
GmTnZ622uJG+eM5RF2N2C1OtOE5Qu5kc4LSDhU837/COBBNaJrSsrKwYvs57kO9EEbxbE5kkQkO2
0r8kzM2P80BN0qeNmqHmx02QEuLbl8CNtLjnFdkaw4jRJFtOuOBTvxgB0URtjbRhrf3NP0qzeiye
mA/XnN9EokofbFG6O1o10zvv0YQbET7583JKMMrsSEecHO2cGAVZHubY8W7MuHeGs3XO8/TMIfQm
hiDfD2OE61nfYiAJoeLoYimpTl012Z8crBDCTFvnqKLWO4w9ZNxANvRmO7126otFyvRKk7Lb96Tl
MnzyW3nFdHBRSNBW7TJONZeIa3qx+wWuf7uDGNUeZ6Mab5O0Xq7hANsY6WFadOV1zYDeURluOHem
KiJJFtInA7XRkW7T5lzBJkp33SK1g2AcRGODGu7erPyBR6hPm1PdmOJ2Nt36GWcr5ynm1iI5zdUY
XKCEq6tgoRS0qVQSbQmYSVj1ybZIIou8rKCvA98Ga88YiGsXOTFJn53YTh/mpRFXIMBELY841XX9
aTHTTjYf+2FC2/sCkyPfJMlxL1JX0kb1Gk/TFPJcNv34jVVBwAqOl4bOmtrfQk2ToMSbB+7PYNIL
qOMHv1WzZxwsvUHHvUsNTIu+mLj1TeZ52qELvve7fDTCnvbT2bBGjR1zF88tLRzk004NjEbayRrR
SWqYd6V51EmGJxcQPPI6Jg+m8sYWZxG/n7DHmEtY5vI89obGoO53mhkK/WTMvdi3BOEwUZitSWwU
OeWX4exy8lFz6wWGNjof89KaOnuaPkmEknSMAq2uYQZ2nZb6AQq0ZsogqdFzQWwxaTc6V43pxyop
+wqQ24Q/9Sz8pFOf/H5QztNaiqp48ExSpvbot3Cm8BlJtJdO3K3Zzicg1SiDahrUcNOmMy4peZtX
LX4Dk4xQqwApxq3tPA+NjbZRp8A7SqQbh54AyaCqdPkl5eIGtk/5P3H2ifcq6zNrLHFpWNQcqrSU
WeDIvNhDiYA0ZtpkPJm80eVqN+0Z8mHvLiU6kr5xdXZtZrWIKzG11Q7+oKujO0/dE12jGRIOBJip
WesQjVMp99kwwsvVO2UcZumXn0Ci3eukR/YX6JXu78wKWwCrB4qWqSvAaUvtmpZ1CifSoI7bDP6w
MAg96TUVKAqY2f4yLgMmiwy5I0J81kj3O3ls0xHlNsu5BhN7XR6K1k4JYi3tfofQ2UL9K0v0DeZs
HvB9JHWaiau/F1abHzIzNT7ahbxbCePCP0QOZ/Wgv5ExYTy4NZApQmw6CtW21skns/pTueSOPCfJ
3j6Q7Pi1N4qm/ZImrMRnA7Of5oVysasu4Wog2S9yhHSB47rdpxnzrjwsKjbbJyKvvCqLlKoUyLot
RXwJtiuSlwKS3DMaa1N7dGZ4lBewKBUNaZ5rccQDYkbWxC0Dvm66Y0gzRLcisk7dzu5SHyC0lgsz
U3SL+AjOOoZVBJBvug4FdZt+k3QsmPiXJXYgKjIK1tJGLv0hN7uFqUOPFighOylsfLncQDAQ685S
g85gvity/wSBgLxzoHYPozFZSYjrqY1KemwOpYXVmT2setRMgt6dzLz8VnaNy1i8cO76dnXtsCv8
pA0soeavTAWmC6hx9fM0a7inDgw797E2LfVuxeX1fiaLzgmBx/rn0cHHKYH4xDYT5IyV1m8dRn/p
VVwkk7tfJGZChzjLlnOL/J8LiVGBCyE1owsE13lbVpHA61qBzrYFcgDp/F44/m8J/Ydh/xazvkQ5
+O1b9XMZ/f0Vf9bRmvFhg57trSbGd93H6emfhbRmuB8gNVmbFdP3DJXNAeoHbm3ZH5C+0D2R1wsp
0MUE+UclbeofXFfXbR0U3DM9hCl/q5J23tlfkb3uGPAyLMc2XJdB3uY1/VN6kLf6iQY/5blFbLKe
Eylmyqta5EsB3jE0DbJFRTYetZAUOOjMjE/YQmbHZ22nnM7tEgAk22jxITu9Gpabae7bOr4oTN1p
/FBvraEJhC7bNzkvK1jaoBKMNPLJ0nyUIpVVifiE0cSMC4a0lDuIwGk6v/mcmEVVWgJndhaxNmrM
bMbgL680Rm3Qe+SYDN6D0JKKKXKKdK9Xl76YTdLYB+iow32bMiK6WZJhsB8tYZcm9c9sASO5WSwD
h5bHf84kiS1ngoh7GNpqmJ0d0pfKDQs3KUoagkTXzxKz00jXQ1TQ7OZFtG+UMV17wFgWuMy2Wr++
84dJ769r6qonrak0wsMm/AKOuhx1hpKekzznchqaDRDBHEE6KkfSmUBshp4EM4n/b81I9FrTRYAo
zd77jrnYg6dAWzGHqq7dsdLJYR/r3MUUdim0Y99Kq4TfikyT6rkZHHxwe5vFzyZbumPw4UOvaJBa
p8ngjAHe++xos2cXj51XLJcWpLfvwOP8VrO9Dt8Ehg/qqo4hMJ8bWZc8aLjjV2HhWfE3BitdfrDm
rJ4+1rZOLRzA1lxwZ8p05P7PUk8tcWbJtvQAHeAnPfpwP9prt4bpda7jKeFA4av8apeOLuQASRl1
y8ZYYznjtfNXCU6UgNnGRQ+lQeh3WmUz/hTGCEivlb0Z7zIkQgXVDm1bwB7PtpY1RhsHKxrhL7bK
1P1KRJMVtXMyPsCeF8UeHgKTmAJzqxvXjGfiooXTLbsFGxEr4kcltUlVmW+j6fWAYvo43mcWijJi
07Fiw8Jab68haXoFnja231jTrhsQHtBVUgxPXx06qhpM2GpxjmlwgDyobPH2Bk4W/tlWr7dBASzf
7bquKdfLXnlau1t1HumACtewd2i8/OIqH4y62ONRs3xkw60vqRvj/Eza9bwGeeZlyTVKIjOJUI5l
HbCXY3wpKdacYNWN9U0fa8866J3gsdEbzXIuSwH9LVogc97JejK80zRptn1ABcr11hOxScFF1u6z
MstJR02r8o50EHcNQG59E6PPVqv2EEVWwGnHjRlR9QV2DLo/6yUUvL5tD5WNnC1UNgODA60SmL7v
EnwZDYztn9h8aVG0stoge9OOG+vUtS7WG0TXjFxC0wc3i4aBGfxOn0atDUr874jFnkWTnSYMaiGv
tev0EfVyij8Y2W+3KQMmLcKNomnChjMzBmKgTCOa01EJJMGZvrmUpXZR4k6zBMxrthTAIoNR5y8m
RIHBzKiW5rle2eor13hg6U3uhRrcOaD0beny4ngSDwU5ptMhG9BfXZF/OCBniqFJATrHjNhNaejd
PtfYdh/bbmXTh0y01RvEkXjROkvjmXM9TTdz5YjbvO9Jup8gEpJc34zjkS+OUYhS3rMxNQz8UIyS
8TkyyIPqgd7DxQpHEYvN2GS29ojlHRcamqJizWuo5wDU3azaI8ErY7fP3N4o93i6lm4WQPggqGCV
nlnD0KgUsjPiKG4w8u6qfWdAQoP43Cs/aNA1P5N7at9iBsOqbs4OGTYECk0WwF7SvLkkmuJkm4v6
M2Wlke48A47CAZagbVwUPZpWtHt4h+FAY/qPxAlWDwLdQ3mVY0s8X2BjBL7uMKzDyyPXNYRCBW4d
OyNBUIypOXYWeeA7w4KxEb2QeZmXmkuWLPCL+WmoXfcZWngBh1Nz7X5P+060bDzD/r+349knsR5x
cXacHBDiE5IbXG7sxIb7pOZKvy9cC68UW+VOjilpr+v7zHPNryNzVe7QAveinQEN1LomuHbabKRq
QulbJM6kB1AjmSxR64qzy0A3HyYGU4NXUzBswYA5LfFgBTJa/HoGkvY9NBJ6WjTLTZoL0sJDzNAz
vHpgDsZYnvXQMGZMb/DoxPsaZ39tPPOIp0nPGaNAiGTW5fTuBdporf3qJQwsrJA5X1uyNJT0bqFG
A1O/mD0IMH1qV4lvDk5zH0FYoJYGiz3mMXW9JkGid7AqGvca0dcijhXNxsakbXo9mnIxpsd8UbSY
7IK4dhJBKIcbeLUucjWYNyYKzHbEdAzM2YxVRJWSjwvYbmHeUZkPPdZwuOruZqRARpSgpluvGLsa
80lgVrpQWIohOWDaNJE/TUbhLfbDLrHbhbSaBAsWbTUOtkHQPTrvvLMvLAtXucOaJF7xWFTjSoGc
J4yBwb+YLHtmkA64LdehDxDev2Y05tV5Bx/YdXcA/HPJtAPvvv4Z5yJa5AC9QE/5PmaCVCbU+Kb6
lJf5bJmRXGGHAqpzcetTyQBeL6EAL1M872DFpsulmnG13lE9y/FcdEPnMUjHL+ggTJlx4da0ZXwP
pZG85J1gx+vikAXCEzsLgDPGkEc3sGaKMl8fsIwkI3C2B3yUlDEekA/OCzvGpkU5cesmrE0mU9j0
ErdczfnSMOHpLuHD1sM1UbMT9rKWhpXP59q0avuiN4jZuDSHVnPONxel4gYVSqUiHxK4y6i0xWXq
pnaUtjwQbqePT1B6yGnCIaxZGeZm85KBSSSNy+aWyba9s2PXqTvc5Y3qSyNFm52X3aSpncDnMn6C
11c1O5l67oNBhNolJ85do9UV6mvtgpOKcEWOPX6ZiKrF/jGNyXIhttcRZxmVQfEAITAdnwsYTl8b
1cf1sWSgO16gj+mKU6znUwbQ4IjpppD1aIcMcl3nWBCqlp4viSXkGb4uE51zodb+UXKncxfqWdJ+
nmlY71s5qCeHyDLzoyONvAyxg9jIAKteZ0d8lpYxnGY1NiwpMJcjc5xabJW9KdOw5WOXvpv8ygaG
mci3aY/0r2wFY58afKi+me5SnUX/z+iZ/22D/gAi/N0o4fx5fS7Srn/+he7z/UV/dkKe+wHWlGMS
T2a4cIM3V9o/JwrC+SB8y4SoQ9VNuItBD/KjD7JtBgcEeSKasB1bmD6f4Z/8Hf3D5p7rucLyuIU2
/9y/wd/hfX5KDHLp2DyT+aGOQSyCbt3cfv5TG6RSgcMRwPieKAzsjr05Ll4xjIR2WgvNPO9taV+J
bKI6/Okk/eAR/cwb+jXN5sdxtw+/8Ydo7Lb27KfjkhTaxFhMrPstFCnQawGpFmOco4lD0NnvD/Vr
p/fnoQhBJMCMhtOD9/TroSSmo8TI6IiO6sk9K60B1G3t9zC2sSsztb/w7/01i+7H0XC2JYDK2oRt
XO2fv9jU+L6e9zMR7+7IEBW+PPB+6aCnJ0e8nqYpTKjgQ+lU93/7azo0s3Td0N19pG6/HjibDKui
S+RK4t4UEDalv1EsLjusB4wdLKq/Cvn6F6f1+1wLKIY9ikXy1+O1Jfz1uBjWPVXC5puXazls4nYd
b50WuieJdWTQ/sVd86uf6XZyGc0RRGdyw/LgmO+O2Tm9kzPIBUwv+vyQO4wXvMrwDr8/k++PAmsO
YhykTJyieTa2Sd/Pl5ABDOs4HdDe9koiRes+ZY6bO38RZvX+CeAouKDCmKP9chgnMmj8+Sip6DQU
XyC+VMJqDa1yzj7ndU1ZO4lVP/3+K/2rg+GawiySySFgx7u7krW/tmInmYmvqUmpT+ePibm6eysz
n35/oH9x7lyhC9MzNzKpZ7y7C2srVyqjgNhj+Htd1HaLC5Q//0W+3L88iIASuAE4JsvWr6eOOxps
CeLIPrbENwui0nmyxt5fLBv/6pRtSBSIk8n6ZL07CAqJ0kk8vonhOSN773qXmX51UaJX3f/+nG13
7X87YXOf8cCyYhBQuJE4WRJ//TqOuUyeBqPvXN/hnPQXj8y7NyfjYttZdNszBHuPb7978ykd18WQ
stin7tqJYMW+v72znNzobytZdtlx7s3aDdWK81JAPvRYf6pKLZ7vfv8dt8P89B23j2GiIBcOf3mi
9PfPFKgKfaxR7Ht9KtZHr4qhzqTABFUIvuXVR1el1hfynFLn793634/Msm9aAH6uAwrw69m1cS8s
EaiV+xiHw8OSKXu/5N4SttxcD3//S3I52eVdzzFRq/16KJHSvCqiE/YNE7+P6GTbb6xpw2mMxYqv
vBzuisYbrv7+QbdH2mEdJg/9fRh7nJvETo0tXsiZodRucPv+8+jTACgHxniERzp0zGasrNe/eVzW
X8JLcHvzuJ4UEb9+2djUiQjWa7lnDN7fa47bnIZUqSemjM0BYUt1o8xSfP79Qd89+fCYaVpM3Sb8
GtoxFcuvBxWTKVzlG3LPWNi7nYggKxmJbNbWvz/Ou4f/z+NQZTkQq6GrifeLc0YgAC7mEhefJL60
i1Hc1KQ636bJUv3F0//+yQAad2x4I6gEXfIEvwPVP1VCIi0dAN4BH78+7L9k17//IluOMefk50fP
p35kZTEE1wsGE3zvXzYaaxBG5gCOMbhObRebiVWdjSkYXTSVGmBgDrzaQ7CTfgMXGdwpKrGYYcjU
zwbTWQMCHh6sGiUhcLL20SVodxviJv6jYN6NzzIqcXwrkW0Tcuf6bhtJu01YaqrGfapEOZyVRbUk
IY4W86uxWpivDJBcP9XKgsNZa0oe80m5CQOiliHaCv3isjSJBLhNTNkgFcws7yA1Z/oM/RDb4qw2
0zuF5Oex6GztKQacvjLy3v7mMl18QSmnbksNG4DI7Xr3KSsQl0JjswDlccDGYL+FRjCHKdkfpG40
fJLIwWfl2KdVZ0MlFjTNkjTXex7i+GpAfNvhUuaBr2cM425bZ7VkiIe+8MOOkJMTjoe2vcNeJesi
YcTFfHSyOjcYQvvuA/zZwdzNAHPQIOHcuDt6hFkcQUBrM8SlaflqpYv5mJYWfeaiDGzkfVlkmKwn
ZnOWs7QjQjN6uw+dYajqvaaSPoPclqhHiKad3MWaXt5C6YPSTF1pnSd2A92u3ETGR2gOiRU03kSL
3DadgZ2YNpYDUW0NQ37qnKplTut2DzEA4I3K4JhEuBuAwJbwaa3QhoM7H2N+oAfoan3mfLDxqE9k
eXITLTWJryWSbT+VXv0SS3u9tslCNLHTbq3+hHapZA6qxdYNYPR0s5RqonFNyBq4GMC1gbLnaSAL
a2mVOgpvMF7WzKk6ho6qfMKH3mL+n00bK9fDZC7hHnSjfmQSGCa91n63fTdkCCGvlJeFLZkQ9y5u
OsRQWyNYbtpbdzghtMiA11m9+TADvADOqVIwHIv+KXazyjy52L3mN22uz+eNAO46kAdArWfas3yi
6DOsAxkUOZ4NlaZ1xzIRDbK1KYW3AKrOJ4Qm0O4Wa8BZGQeT2D1ITGzWUzI0kCl6wNJdVThlE7UV
jJ+dBnF0DnNMRb9ZGqOIcGrIY0CBMJrnYIGpu6+NgfQZNQz6LR8nd4gnQiQYxvFgESjRNTBDXGf1
dcIoauwAk6mG0wGNdbpeFbasIRK75YufmFBDiOacu52IEXZcFPHS1wcta3J7p82afiBKwu0iaWBI
u0tyXJEJyE76+OSmZd8HhK51ya02VDGYOiO+M87EgnM7Veo5nAu/Qrg9GE3oQSX4aICmpMjfOl2d
xQb4RrAOJH6ExDH02s6F0MOSYjFrOsRNthIRiJEUUDk0GYORbNf4yWYziFYvQaVEPEnnJmO4YHZY
h0zlk69ti64zkk1pi31mzzBvmxKrmIOc4UA/IKMavIj4GPJyBMZ0eqT3njExFmqlDrfInR4ntbhr
iNvf8NlogIE/TmD4KHNxQN0T4rW8aDCvgL+E3otTty4r6Q3ejO/yamXd2dwwPwzxWYZNIzGuOiV6
2SYhxg/t55L1rcCYrZtesthWVrSg4teCIiucgZVrQd/n4my/Bu6A3Qx27uv6WVD5X6hGb5cdGVUp
UjsoN1VA0Z+I/aTLqg9REpaHFhozqpeRfDziTQn2ROGYDm/TyBQlNLKsuIqRq9V7IKr1tW4UvybM
wf5EkpAxhNDpuAWwG9KgSrl9+jz6aXU3ulnCi8sYmgbBDJl5XjiwEAKSszLsb4RDNHbPvHA+1E46
2qcES41xR7aspFdecZMjtzJuBzQUbi3PkNE2R4kHLcb1dNNlEEOchBdvOurU42zErQZJaF+Jta9O
STGMZmTmG+/PmCs1RGUKkLszUxHfgJuV38ZiTi/7xeXXGj1HCNxgjtbBvEJlzy7V26+D7mgurFic
ikOUZ76/0xrbIQId6GDccS1S/n9RhNejb7CckPgWJ2OwMEIIhlzdO0ej8VHYLNS/3BuJrz3oBjdW
JOrBuHfwA/yyjM2TdJFr1sRXnRH7M+/KfKPz2UOvRZntq0tt7LOvhNu+0CNMYebG+rWcmAapbEL5
sJYF5pJUFjsnae6simUHyxBMuyJKlvrpO7gSqpLMIQytvYkzWpDC1VEioDNZ5ua8XDISQXzJ1A3R
83gWI7O5gDDvsSBUu8H2UU6a1x0myggl5YvS8NhHN467oNa/QHJe7+Fzv8H62Ke6SRSBd1+iNyH6
QX9c2iQiA/Gxl/lR1OYdGl5MZJuuCxYvzy8td4VhhkxIkDsQrCbkPqk1F03aLudL8X/ZO5PluJGs
S79L71GGedgigJgYVJAMiaS4gUkU6ZgBh2N++v4iM9taydSfsrLe9q7KMpMRgcH9+r3nfMfS9k3G
K7Wwu208R6vDbuqPDBxQHBbejl5kAzW96k7d6HWPFg3nyC6qO8ebge7nWRIWqsPXOGYDlpYGZg7W
+VATtToiFHeu8/GtBifvYHRVek4rb8Q/SYZ3rBh3rRuVo8uKdIbDTJYb+WZJo/3hIvEiLczvms/0
hOWx8hY/RIHuB5iEsKor1yC0AZ7EKxYZc+W384yBjpTmhYlF/2BXFvVrFiyfM4aqTECJSgxzfshu
GCd9ZwR1fralWB9tZbwEqMpOVpOM55k3h5H8amTPaF6RX8HrLc8Sw5h2NSpg55n63v4hQSbMSFWH
RP/cBYqMIS6IG3yZxuVb4lgHwnEfMKetzLf7LxgwVJim5qXH5bwp1Gw+1OD4Z3D3izy4o+U94CGx
3odRuVAfxRITZUTZkenXCVwdkr/QDBt8enB7uk7vvieUsGj+UFgCvQCUxvRl7PTYKTDpM8TkdkYW
g/kXS4Gwb0wtR4AQmNVeesqEvDCpOx95QuQtvfwEGsL6nifaOj321TJZMEKTTsTJ0JT5ptXl8raa
aj4u8/rGBHuImwkDQsLJPxqbynkahY5/Bi7kmxpxZMmmoKAY0uZxNhgYzj5tkOsrwuOW6+50ROEA
Qlh2lvm11cfhAOtWf/dF9jLjfr43V+Ifln7ZUxaVMW4A7V0rqgGTYSI3S2E8pzBHnxBsjxssPUdD
6mIKCX4YWJ4EEt6pqIlEDvyNtyh5L/spg3eOspjKBNUwUtP3kalaKIHpMpzNTTgO3horL1dRO2hr
S6ipicQsQBZS1JaIUZoyOpU9AVJGurzlxJ7d+e2qobUioaKYjPrBzaZ9oK9nX1tLJvO+4R2l03Q+
U1bXfVPpUrN9NlrdERpUDt/AsEJOsLpmiqlGdYYfVb9d3JF0mkkvo8y0tlOCysk2MzPOcSDHwAWc
LPK9tThchcLpZnbm9pisFa+s0c5biUYFJJwbgLBLYEa1Sje/2zaOHgS1j8ng4t5qFAMF0QbLUeoT
8aiJLuJ5SuqvVjEYn3tcqCc/v3Lki9nFhVxbn2svyR6uVkHFDnF1h2c9gaLXqvaMwixHTtfzUFWk
u5xs9rJrti/qOmWmu86yp8iFakPckMWS4vS8cgvRi3tNS24KbahiMgvQkLNpbWfkkVjTlKJO6YsN
sEiyXLp64czBnOSoC6XOFH/QQ5HgEjziYNNKKhS/FNVMLwlUc+5yuxof7VbNFl6PjHF6QjLvDunv
/BXLkB/60OzamFG6mrYMQ8WZLu4abEZrqbwwyEfCKcxmYdWgtjtO3KVtGmDl21D8MaG3Fm/bjzRl
EaGXFgXyChoD5pSWrLFXTdgIS5Ch97lDIb7PGbO/Voh/s5uqSnzrYLlso7dJw4opwlGO0wnfortG
OQElVCpGbcW0fSXAItlQd/gYbmOINgzzU63eVT4FLeeuVBBsZWcI93ENrNV2ZXbN36scc8Eou8om
5TcMzIj788CqT82KHkc/TIEcDhJ/Eo+C36Wf3V42w73U7fbsK+2txVsTLYs0YksF+kYNjgYQoan4
GqL/ElDbvEm0x9VOApV6uHrB4yZT+nmy868D6YvoUopzpqEBwo1GmlFGObZBAtR5mylzOWR2fjvv
WIfyIUKNLQLyVyi0wkUE89e1GGyQqMqqd/O0FNuZTbbcgFGrQxJk8MVIzq01DIVorK8LrUujIxWG
d6hT4xbd+xMJ4PYxFclG1hYgCoqeI9oV79ZD33satXq4uFrq1ztEH8OmKqt0LxILCULR1TLMXJKA
+hIz5h1e/PaUDTapbE5n3uGb890YZ6VELKyj4EwCVOCZrdxPzmy0keZ0+xGBVrjmQl8RNwpxx0kK
8GXTKUJcernXyLDDJDuV+Zlh+FPXqmZneYvxKo1qeXSsIuU0YnIqcjSSzKuqRd7I+uRF9H/aLVfg
kRmDLiNLQGYOayYbzXYNisoOJx+pGthooDwx70J9oCT0dlYn7TxsnOYaiJCeutx/NVey4XszuMVU
UZkIokdB0AsZXHsv057qpe2/ZIY2fvITX79LK1XHisABrCDzd3eW1bk1YCVc3Y8/eLIe6bAhPVkM
zLJe66WncbpGqksLLFg6PjAVQRuWafBcSbyX4SAm/WDUYtlkdfM1FdN139TnnVH6FrMLUD33iUdb
KTStVb/JhR/sLeRcGyS7DdyFynyieMg+9yVpsGHn0kUPQVOJNiZou5x2gZrFZx/i7XB9sTHdoWbh
iaWif2FnhI1fw3fxWUuppCoKDA/XSmmIM3ST5OB3rnwGqA9DP0c88gVJj85lNXvCVhj1XjCujCfl
uwkeZbzGboyvaz4hthhidyy0L0a9oH8pAAeTq1QRwzMN+rPN/78AgOoIAirHb1gBv9BZsreiuCqN
kiYP0ReOUYaauyD7Y2q3vgcOf8Qd0VRjQm3ZQGPFXuaz/7iV/lljkPuWYRXei6p9UthHtY0PuxLt
bTuykSIK4T+i5nhrsc0ya08JrLvtsADPX3QUFz9Sp0229H/rrwKK01MvAitDim1lscSy8t2blySu
O7fjz6B7RyPfds6yFaNOApOHReecWKzJuAaaNyI20OIYQrt1Pc2vjrDktHtZXs8MozksX0EkVlTh
FBGfkipIxh39tLqKq2lxvmSICjlOUN296GCVIkBj5ZupZHEr4dk/Ts6oXyyjhVVCo2jCOdEHqAEa
CHERENFxp2tGiSYsr/0zGhEcsW1v3SQp/uMtGY9dwHc1iTQasFeHbb5qUVsDGN3gByY3U+NyECIF
nAfROn6LAEUAd59MLd2/gUJjzlsI/QgripEU23AZ3P5x8AWl/kw6xFEpz32yQdyR7YgybWTFRlMV
qwH6f+jgSQfDunry1psB9pFpN5QT7sKqujXdAq95a/Z1semaIfs2WFSUG8xPzV2Cz2ZmGmSS1TU2
hpGj6liWMZqMVX/NFIt6FMyAxuFO0z4Jy4zwJOJ6S4rQVjcHIFYQ1iIXoKJA66AJI/akrx7Q/ZeA
r1Vf1RuvBWyPu98z3jVfr3DEq94QiNw85HUSLqcI/aLUsenMIxl/LeUAwm5pNztaCUXLVpDDJiwx
+r8nzIenP/T1LRb2ab1tGMKe8mXh+JvnHqu6Py7jXWCthRElPPZ32hgQG+IEAxbtSXYcJajl5v4U
zGLu9jWT53VDj5fToJlzOAFVZH8ey4IjypzI1dpAAWfdW+xhfaZRMxJ5Oan+hAN1qEl9d5BGXfHK
XNfREWfJBr7umlnnBlfanFK5dwHy8D+8nDWWN3J+S69kimgvybCx1cJjwqtFuFqHYrA+TNVgqHjN
ab9QPRrOqZmqjuDr3hvuBVuVRgMGL3sECJpSvUaqUlCDEuV8I7EP57HX9W2LEqrpUGYowjQxWNCh
8uYy+D4atGzxtGUcPGj5jXSy4d070Cbc9gxFhk2zwW6MShgjXwWagC5FVDjIOSixxuolswbJAjqP
1biZx8F5t/DfPcuA/G2EZQj5Y6N0Ri8ELz44uPr15dYm4dEIbWXJs4crttoADhTf+Yvue5MipguT
UYmvjtn778qaVzfUURxtLa1CEJPj4lp2C24UDn6Lcu2wZtpohktmyjZuXMQmG6HTdNuoBL/8Nhg8
63nJCjReravpzt6VmOHCDJxOHgU6ubosksNycnocONfmF12NpF3FGNPRGs8Ca5m/0fwABA+0Ts2P
IA4q+tRONftRR1XEa18jO94NCmTjAdG2cOj04dEG05lZaKuvSUZiTOudgzOZQKBZtkNoNFqBMNYB
IbaBL7GUhE2TVxMGknikkBaci9DVcpcXLPvOF35zcMn8paDEQmPpAnoIuu5YDyM/y+c7snESjkNO
61QV86EsevtZJ/cGsAbm0m86ilEtKj139CO16trFwDYDLoEc9HUDbsPrzx1+73pjsMpflIGaNlIM
v8Ur/iqRfErAPk+3ciw44puuN+DMqtclpQ+YddAFbUgJJx+quLXJdbTgxGFpZU2RD3qlBaQBkmNw
Kv2Tg4HfPqxtr7X2O2WqpvyNjgxWrRs3mT1D3onCFWV2Eyijr9g0PfDaTYyAOclQDjnMD/s99rDC
dTer4zWa2DeNU9asUG3ZLJupaNLmjlAtfD0A+ATHabRSyGB1qFNRyTTHjZdgLfSDP/jIPWqL4j6q
dQtbZtvp1ri1G1VVTzqibsztBgf0Hf5wxJRDMJdJxKxQGVgCOzIzplL3gUcWcqDkZrXeEKiAOzLs
8jLzjmrk/AsdohbXHvjq5ckNKWGLjBNZivl5bKWxHsy+QCA91Zw1I9ITaE2bGoy1mP7tSGJrl7Rd
ENk2TLPUmqzmqcf7TQGScbbm+c9r85BaJCp/7QgwIJnSNoYylq3RNt/YSAbrBgF/82M0BMSzxc84
qC2TxrSFXjDKBZxvnO/nlrJ2V7jKr2NyjyzxRPOgSz6RnUoU5NwswUxcKMrmyOHgg62pYIBPn2AU
8q2wVavtvI6EpLidKyv4mpeKCWohDVKGFzjIkMr5RXgb63x4ynP6IxsNKEBL/TQkGdllcLJutGVZ
reNYJXaATO563Dqv6ZUO44uENEkg2vZny2kh0RRFOb/1o6M/tHaHv3HMlkEjxi+Zn8yl6+2baRz0
bJcYcx2c7JzOData6h2hrePkyxDFjhs14o++GyBAP9DwzViP01lp2lZviQphs/RFwDM1TMiAYf+Z
4WiglXlOYISJk+2M9nAHDE8rdkiztWVjaYTNhS2BCt8sR/lZyKOku/TMkAbEtsg9EscGg1YzzY1A
x9HJfoFOcXTtaOQ50Y9Dl0jvXrpIRtn/C2rsyXAZg+t93tMNtRCtxzSysxoYoYBy0fa13W+TuWrr
/eTJ+Z26O7PZZOBn32fTbM0vWS3aJBYtxE9QYMQVxAWWYxBzEh15udErzyp/mCIpFyqdxQpimphg
ghDlAsPXRkZgGwbn6cVfqZ8iGMTrwkli6ghFs2SbviEssrJQayx1IZ5xwfm5eMZltQuwF17TaJdV
LEaza2p3nDfEzXlqRw4aubjSm/s8MjBM5yF+vjw7uFNfREltBvJGIVy2Q6WvFuGrrX0pXRuxOpla
w49AoF66wSzaZeECAuOutUY0ul1VuReb0/A3B0tqfrsQ3fRu6SQbh04hWu0h8X33gXg8g/+sV0Hw
dYH0P9/VjH8uC3x499jit1xvAhufBKQeDpGnQUtxLpS93gQ7CzwI0ZkLbNI8BmrvO2c07eVlFt5o
bJW16CQvmF36GFx7QpymexIk8mT4QZOMI/japau/mzs6JNvEGIz6UwL6lLM8T9q4ccrVrrZpvTr2
hjju8ryqpPtEIYZzskJnXO9kW/vFLtMXdzoNbc4Wj0jI+ZpBs2o5unKWjY1EcvxE2TzxTso8eaV2
GW4qorFbvEGlWI5+hz50O5MdcBEyYGsOap0CUusJ1MO5D1MKHf3axZgqiy9S5Vm6m03w3FdYqkbb
F0sm7RyIPTEYZSCSYsaiJxBuZhsH7RcRkbabaPUNa2phfuJYzDhEp1fb86IbFvDLuXrXBTlg8HbI
MeexXGtr25n6WEWKoa9xIGa5LLfOAAxpA2aJWVLIv16N5P2WfFW3Fd6KdLnOqfrJIvXmc6HpI52l
Rubp1ssy2VzAwBLO0SUrFFwyJ0GHNMHUrRtp1uK5qn1cpAEgWDikPKojcIGKc7ZHC8IOC3IIS87l
gyo3mXLyl2BeW4M48Dp4qaqB4kUv4IrEfceghPosJYqQl450p0/CcBeKYKip+k1f9DTZSFJ235xV
d9pNw//Po0Tvhv626AlBCK3VkjoQRK86EkZK/8zSrfm7TVrLDRM8QNG4G/WbCuk/rzzQ4a9QrD1O
0CONa+rCKf1ioOetP13dn1ZUsJ3suCWMbRIeWjc2aB16oFjUuiea02WGn1xzL1K5BrgeqsrDxMkP
obwmLBdC6TKCEmWe0KZHoNBWtVubpEYQvhhuv5tHAcqGxjJt/0nHOH9U7IlEEWqNeIHszOiXoQd9
dto9NFKYbWp6OA7l+oWQdqkfg9z2pyNpXvp8WH2P8lCQOtnFmAUGP1Z+2mIRYPCN2jOnP4pZnXbf
rHvjutcVJMM47fWWmZM9KSMc60wnCHyq33RlImNM0XGu1Emg4sOgbWe04QQI7ydHUCJDEppPCQdo
ShSC2TM6NP4CWCyD4xDCeiu9bcPQVvGmSirwpMbMFZdlEGiI/if9OZGE6bGA1Ks4Vsy4vy+k8RRx
g06bjpbqrwUYbZgqzlrDNW4zNsd2i3R1pRhl733AU10Db5go3SINLK67I80Me02Gwr5m92+t6a4c
W55Ifcyl8VVRun3uBrYjS8cAtIcn7AOHEjDK2bFWp4n6vKj6BzBBJQOzpNLe1sWt7X3BVzqUtTQf
KUoKJyrZ1ivyfpzkC/iBpYi41tcT6VqwOCxGZg8k1yf2EoPmIJb1ymhe4OPMRnWgTd/QLcRqkqp9
wfP25DF2J/pZ0UWKUXNApun1Eo50VRopJCnPI28ydGvQsVHmwoHfrmQ5lt+m3k36e0fq2SnB59ue
Bsun2bZaCGlCqaGOv6GD5LzUxWz0UV9YMjlI7OlLLCcdsplpN457gdURnAfTGSeS12314Bf5AiGz
LVuHPlhrEE5Trq3FyNqdPhcGYZ473IeOc+w020/2GrLAYD/Iia9IeQOzieppxZXICXo5YJCZ2nMh
s5wvjfNy+jRi2ZhBcE0aZV6iW2QgJkMFjojgdHqui+M3m1UQzJ4D/PJ2qPKVfGlloZtXJBUtiTi3
6eg8owVQLzMGu2HDdWRSj+falfE6SO+2SHL7VUiRf165e5B7CmwK9slxeWdjQ3nep6UUsMwCd2lo
6VJKo5JxkmrYZSOtwENTcMQfosGhBRRbyzSB6Kp077v07SJnUFriXAeCBb7bKfPmmwCc3uxrpD7B
ZimJzNjhd6jk0SzJ9sJRgB6S2M3U1l8SI1XGCUfV4Cy07HCSb+x2kerRW026xCeUxfPMVDKpxCMR
oVQipIuIGUpG7o/K3kxexQHMIMRiuknXpQJJNZfVsB08V6pDO4PCO84F57zYG9Z02rvsaWOFwsY2
3xIYhm00pZhEAAaWRn5QMDMAyPp+/mqVE5PRthMOGuXZ7dybiWLtR4EzrIsyEIRjWMrO8e4H0nac
i6emqQwXaB1pyFygeBvRRljMIziIHYvrp/WdZv1gwkkTppvkJPfIU4Z2RzerGzake3ruJnMcIO9z
Zw4PkznOX5n9pWXs2xacdjWOkh6+ntrvVyaF9olXqvyi5lH/kjru9OKBbr4DB1BQ1o7AlFEx5aDb
La8DIuA41f1oUQ9Eri0nBgTe2qaR19KfCJOE2VmYmcb87nbQhXfcY08dcuGYU4yvqvJuyXqe+Reb
EswTow37hTKMhgME96o60eukcEJnA26Sl7l6NheN/6kxvURz3fkWw6iMUBVmEZ0Ej0/Ub57FBhfc
PeG6yv0t0Haju0UXmXacaq3ODAE10xy1ZqxBW5TQSmxkRQTExpfFCkDRHPJhh0XUxtVD2/+Z4G4T
bZJRMdvzJwuAsKtBDKOm9liGSSkR3l4XouBA6+CjAs0n5+CEXNvF1VTUpbGnaE6e6TQoqoJCM/6w
sHU/SBnXGJhObsPZuEv0GK8YpDIXPdc3RQgD7q9loXCGSqKDbUwmRy77MiB290alTUHMht9TTmiY
dpiSLmMlTotJ1itjegzCN0Tb2bTsYZHcCHrsVQRVxn4INJ2pbWUH9Q13Pw82Wgr0Ni6Sqf+RFQq3
b2NQ016j9oCPl1nQVmhGm0zb1Bn9QUx2VOEw2mTFt6aao4cFdLq6yW2DurfGk4YGf+C/Jr18zJ2d
VjPN3JTm0J5dUvZg2yE89PnzRWlEBvFteWhPoDQ2Wucz0A90X56mNNBkpBOU/erDLoc/5wzFk6eW
Kyu/JCyGKTVjTVJOc/NWpFJ7FVy0L4ginDUEqFi+G9dsyC3IAjp10+xwyxTpPJ/StA7MM9pbGtF8
rWwHD8G7IjgaqAWmo7l380gFeCVGTC8D/QhCeqicHvp2KonLIy9H0Fm3zBZ63JWHY3HguRtF7X7q
GV4+8hgjiJnyqeEgKGbgJuSLcMiil8UUz56EvkEq0Acs7T2BAdz4+g4G+kznqvSvJU2JWjAkCnh8
Tjj9k3IQoI64DkzVOR2HfkYYRuRMaPal3GauvbzqjuncEydqfZVOybwGfgXFT0CT9QyZorVjIepv
tDS9QzEN8/I0pr7zbXJt8ebRBK0BB/b2KRl0UuHasjQf9Nkr03PdSo3e4cDLFYGydl41m7CPqMOL
zZFTVO6rQ8yqdkd6YG+EMOWFubfzxH33K6AdoBBB9JRIo1A/wYiiDFvM7NadcRtvFEtDwAFSM5Lj
gKVRvrgKPkioJ3l9ZbkU15izRjE6r4qEwCuDzGCmx6ume+f5GpQdCsV3DBMnCaqwahARnJicYCoz
CqWNJJtAoIiUPYLgAvoD6rpwbB1pikd5h5yYIqNb++zd5BXG189hUUXIY/p2i6DL1w5dY7rcYzK8
B5ikNv0ku1z0fc7xe9xA0pHtrTMzBBpR6wUbM/fMU5rnwbRdSH2+a3DwvhNX0AcsqFcrpSlglDi2
vbISrPP67lRF8YWkMpZ3qObqB9vZgJxCw7sQklYwrTE8EKNGb9Dn3ecBpwFiT+UI60dnl7k8rdcW
9HuW5Xr2Kn2ZFTFMpKLDit+AxSrB0XxnPlpVDM+HZj7AWXGAV5Lpg/kxmJfba4+mj7De5rcS1VOO
vlRvsi/m4KZUBwA/1p3XpsJ8RV4AEDejQbc+8RcXdwukm2NO0ni0PZmMwK1dJ1I9Nk3jVwhWhr7a
1tnqO5FWlv1SbfpK4Rjld9AMHJ3Wbw5V4M20/oFnMbJyBEcNLKydtMwr4QtxmrKTXMRaB6w3pMHH
AI6xTTpsHJ3mPTqFxH1q3aRygAPb0j9pdcksVpcFleSMCiM0zc5ZN6TdV8XBFOgXP/vMEW/ntO8a
2CpNCZxfsRDuMcz7VFBjZ257IYIG/LeHJqGg09N8so2m7KPEyayewp1MZezRIBlC36yRYpnjksmn
tDMTxE/TQn+6peVLJw14m6Dee8Ewva77MRB69zjqbWOeKXDwX+VsZNVrvtpOcyRXlO+llfOUZrdL
mdFAhChPVEzCwazx18gRo2C+WQAfjn2O7P6pkk0u9gj0mvqkAbigk+Iooo4jbPV9c2sMPXJBKiUf
E03r6hr+3MAHQoOdWvPwlnvQjNkjCzKdp2zLnC63NyMQyMyhiNAIjYqwDFfqNbVl3h9ba1WqDdU8
kSYoCN16pRQZu203O/lXDJv4Cwa87sC1eD4+VyNSkahnBEXHXpu7b4RIivLO4J548YRYp7oBpZtV
V7ABVl4bSpq4X5qpm56zzNCH26U2m2GPzq/EOTmtCQrTOWt0c7fgzn3OhbDeFQ9xBdoenzYRoPCm
GUqOwJq5Z4oZj8522LFWabJ8AF5m5mSPZv4UzSvpSiedPfuJp3fudglDljeitrPkxlD9iCZzUfWC
T5zz3iHJ3Q4dhJO7pBrYSGo2+QTpgfxoDpnfqln4drRamGI2WGeHVGcPwSnKeKtl+8gI1hWfbMuD
uybGpH9CyNahTc0LxuE2CluxT8zKpyurcXfZOjBLf3eGCpCcURFzg5aC1MZrn6MejzVTb19scLR5
ar+araNRAI9Z7d2jSqnoSqy29QpzTOYxARa2Tnun5gLTyRBZnKS1Qv2q14WDdJSu+NpGuY7Ga2t7
o/ecwpVywrxCDIB9vgNc4XtuOx6dMoBf5AoE5ltST9PqKAzmIvvE5udEhB+V7PVakU+RMRN0R39u
yIEHCFzrUP6cRRt2Xo9R4AY5YctOt/ZOg/9uqREImQOjy150U7Aj0XiySIaYKWA4/kBoMxcAHzeI
suEupYv0WiYn2Spi5kv+GqNyrCiNFhqeGOU5p58HvYcKWNIbAr3EfVe3tumgh+RW6/nNbE49WSZI
Y1ll8HdOF96Gwvism/N1QFlqnU6tsWr3idm27snQEt0+E60k8Z/67GUHSbqvEbps6Bo4YB8HlHOD
ZmPkvUlrEDLP5AYJedNwOKV/IyutuG8JXco4yFm0gBqz1aonRZzTUKN7F+qbljMlvCvapFGPXYMw
9BSYOSiPArd/C9m0sTP/R9atzIjCPKUfDtAqqehSm5MNSlpMdV3fq6kxhqdBWJ4JtFTZGrocZND9
Sv9UtB0+bRiHYMrqysfsb5lglMOVGsc5aXzz6lkz+7QvI1akREWmmbTDZ55/fcw2iV4GPQSXYAbN
Y+NaKHfjAv1tq6XDIhAN0X0coyDTuu6QF20ljkvpoeZY2rajRcEc3//RZIC2nojQ07XD4HIMu1/B
9yNfkUmRGud1MoYJhYhah69NXxjmbQs8249gZnpyvcrEUcdTwgpmwGWRr/1y0whXFMWN3QhVm+cx
KMfVRxGvJV1Ur4xIdq1daeUnmmxdc2Jk6WRProeM5iZrUrWcIVOg2Kuh4gbXnQ9g1UrOXKiUCg6Z
W1sydOmRsrYHOazezG+9PedfBoegbBeUIB1iRdwMqAVDnUPRa0nKDNF3BQfjMKD1exMMNmfgfuQf
3Aw65yvN21MZCoLRTAdpQLIDuCzseZdMFKvtBR49nadDPuS1U++Zg5iEVPl61vBGFiWqxeXGJ5UE
FogzdsP9qBNEQivJqUqvfxxptVy95VWRt8trBS0xtbYsba7eH+15TKW/neaeLtmsId4WkWWsmV2C
QoS6huwhW1QZj0SLIQRt2ySgik2lgx5AKV9IVk+TeSCbsehcDRVuWi0kDRFYzRwy7UcRZPEEocd9
SJIkzUGLwV+11AGBmDPflZaps1WMfLfgYrlZMu075iprJDwpaIuWddVBKVH+rm+s/FECLmCt1IV+
P1lr9Q4hSV7zdSbnjW1ttKlIpf/krXXyEiDSHcIWOfFn0kODHeSgtdtXpla8GOCin2rNCZ5TRcQ2
RhgiQ8CFk05NR6x35jLGQWTgXskauVnhCox/ukr/vw//fxkmzr3/Gel7/NZ+sOBf//0/LfiGY/0n
oF9wxYn9BfM1zf/gHsPiixURcz7/4C/nve38x6G7YuAg5XlBVY2v7f8iyGzTxK/AQRDuMhLu/8Z5
/3dbFpgtj+ExH2/hacPG736wZfXelbUKSfdSWsKj+EfZ5BL++QmfWX/OW2fgkJLl+yDXnYOyqvH0
09W5+9P/9bMB/+9Oun9+/NXe/ZPtrE6vCQ10Ky5bOT8X2vO///W/u+D/z1/HymoYBHWZ1gf/nENr
ezF7q7vMBtKwC3OJxeC1Hg+BP8Sa+K8snn992vWGYWz23cD48Gk0UERvEmlwGSgFcFRE0nmz2t+Z
z/9u1PvrU3zH4+4DLcAZ+PcrRspl4/uNA8+7OyW4xubqbULLEQyxV/xXBuc/PwpOoe/gcnfB4F2/
ys83B4Uqrq25u0xp+9C54jg51u2/36Hr4/XnU/FHvswfjx99zmtXA/6E8fGadTXpZX7edZcmEOND
cj0lFkYPkijX9N84VH/1MHi8OL6j8zzwyv391wg9b/XcavrLaNE7QBWiJWSNuqoO+0qgjjDOc1LH
//7zjF893x7oQXRSth3YH/l+VyZfb2t8aGXUrNaTS7ju0SjfkeZyzDD34zA+oTq9m9ZthrLagKxS
BfZW9t7Dv3+TX13on77IR2Q3Or0uLVe+SJ8NoTtywBjDRv7GF/urxeTnD/lwieXQqqKlGXAh62bV
zsVyRPSpGRbRfRcgx+p37/cvry7rI6SJAHSJ/WHxygqyHtuFHwXwPuz6ewRSf25kf8uJ+t365P30
CR/WJ+jOo2HT5790Em3a6jDvn5PfvGZ/XPuPL8GVvmK5qN2u/vC/P5mBF3Dsgkt0Udrdmtw0K2HP
xl0gvxoW2ttkrzLiRVTzG3PxL2/WT596fV9+ersTT5H1i8nsUhKgMo2H2n5MpiPYJHi+GwufAsV5
9O8P4R+Qk3/8UiK+dFZJx0UC/OEzE1qqKkv7S41oUzcO1fQ1Te7aZCcFoscDWYb06N5U87vf+ssH
5afPvf7zn36ryJbFaEXG56b22SzUU4LL4d9/2y9fMBfCAZv1tcT7sC6nTQ/YqU3UxVq2nXtbpbve
/I1H+4/V8B+X73rxfAgNYBQ+Xj6/1oqMFeXSI7Zr5mCTB/euujOHEz37jaHeG+87AmJtJIjxU5X+
5uN/dREB14AOstkNGM98uIiVFqzS4l1gYKYzT5S/uYK/+/sf3jVsHSB2bf6+xfEVGcrwG5TGrzaA
n7//h9esGBswnFi0L8MyIcXKiyaSwLFxLRg9UybQlmm5pBe6Fv+vv+zDq2aDGcrJZO4vDVxHTjB0
Zg///vRdr83HJ4MbY1wpHroP9+fv98ZYmASgz+fJcPeB++hz/vDvM+PHv3/KP++QpzOs1T3bAfLg
WR9+R97zXCy5rS7GVrPGqDSn6N8/4J8v0fUDAowkf27SHx6x1RMEcMuRD5if+mRn6h2Hyt88Zr/8
DJd2NQQfYCRX7O/Pa4E9lXOBrFFdJlQ2TP/N3fRXoMn/uGv8827wMzwXLoXluWbwcV9CM4BeGPDG
pfEjF++IYDeMi+I3tdMv78ZPn/LhfakwfXf/m7TzWpLbWNb1EyEC3ty2G8PhkBzMkCJvEIuiBN/w
9unPB569F7ursbuiSYUuFDEhZGdVVlZWmv/vTKX2c/OvxPjg5fvrm3F5QaAFnPWEmj9XStiMjnYy
C1pWLojqr5jqYDnQHUSjSvaUN/dT9eySib8ucW1rlsiM5w6L54o+lAbOfAZwt4HBgfyucXCGnGhd
cqVLhHgCoo7WG9SwSBz6Uflhtu48CBe0l+t6XHoaiqYYAJ3TJg22ItoNQOkVPeuc93jYKe2eUbfe
BuGTavcuLiVebV2dX7KEM6mObpTRkkqE0t45wJCah8SVnMrFMZ47l3N1BOcCTyFN2FXG7Ql9VQKo
cefUkFnpVNq8TV2bkgO6EiWcybOFHVoKz+Gss3xR+BLgLWPlUaWSC2JH6947WKJCFnV8HDXJgVo7
tifbZgvhaxJUYG2OhJOG9tSnH4D9Nb27tpOspkyKfu5/eqtbcOiRQrQ3Jl/D5CmqX7iLrpugxCxs
IVQoWzB3Pdqu/Eh59Lyd4W7dVrJPa/7ndLmWv58EVaNdWW41YRauedCHTaNLVJB9f1Hx5Pt1N7Yz
3TaoMH6hzUtVP15fotXvg0Sjg4VObkDc7qIwCzWjm80fliRr8Tw3P35DAFBAvPsWQLwFPfFUASWJ
DHWo6JTNky/RISk//8bnDTwlF6bD60HY4hqOX+bDtcY3oQ6rtrrEia0uz8nnl7+fLL/JhPOCldX4
qk4J8YFp2MP13796ECz8ueZyW148yOHqMaYeHAffSYrH4/y5JvdEtmHf0YB6XdKqAyO9Br6pzlNc
vI87lxb2euY+1ujlVe3woNnQQ9c6vRMwn/B6nO+vC1x50uHCPNRyLPABL14D4AJCDQd8n99n1sNk
DksDyi6kq9h5TJ33Q7609zGKrEjkri7pQmTkQVxgcfOc75nTxUHYBWTzhrTeWJq7MfvnY87omyTc
XPMupDQI96ga8foWLDuEboc2xLzx05SXvglAfArL9WhKxKyZoA48IZcozWrA052ro7hWpxwdo/WB
xfW21jxAdjB7v2Ecp0L0cyEAjPatkpmtDyjavtMZcU83TfW16A9lLQk9Vh5wBFMnColH1qmCrk4c
ZMEyFrwODaDu8WGCzl5RfdV5Iv0DPiccWhAOBrs4l1xw6+vpAcG1ZPRsMS7Re8eCfUhrfYux0rnp
3kPW/vW65a+JMDRHV136NggdBQuEdEZLDfAwfNJ6m4+wNkl2a83CT7+//P3EK0VDHJiNyfcd8AUy
e94o1TNQD0fj7roeaxZOiz+PBAJg9yKZm1WO2wHm3jFjYEOuHG5zpv6ybjhcF7OqDsNyJsiAqscD
7lwddWpcK1lGwHlHbEL74AEArm9AM5cs20pEih/ycIDcdeAvCoa3dKWFNO6PfsH8jd0O+1l7GKoH
J37WIfeQxaQrRqD9fB+aDNUSxgsBo5KMQ1Lm7eTb4Q8wvxbS8f+WVFaKBiuLphmUTQAgXp6jFxdf
Yk+9FTkjjpsGvsOcP7TzHe70upSfaTch7EUM9RHdgatcXfgUT00tVzuHUu3MmkGTYIRvSTnC7/lC
Qdt0nvXwYBURc07MHINAX0xQjVA6p7poN88M+Bi1K/k9q1qb5pItJ2JxRLjRwlRpKG7jyQfnoKDw
P9A8+ph8u6706s6dCBHtEb4AbVCTCQeVb94KoM2vf3/lWGlAb/5XCWFNGSVPmMw7Tn7SPAwhLWMb
I5OcXNk6CaYOU1dr9UaOCsnfXrKlE8qiLTOUKCJbqOXvJ34oGZVprmx2g6b5kXxt8+n6Qsm0EPyo
CeohQFEZC9U9RgWzze9n74mGoT+TsvyKEy1gyDQculQmP7beQca4tXq6SLxHU1Z7WV8tTishA5NB
4q1AHzjDIFEx+XAHAR0He/R1PWTfF/QAz1Kjnwmz0ubDaNCrIHkqrJvtr98vxDtB5uaGo9WTH0L2
px2qnkYBiQqrIsASNmxSH465FIlPt8JwwzyLumD07WljlPsBKjxNsturq3QiQlilyqjHvMnDyc/r
Z3tgEuDlN3bh5PvCKkUQPlgRNA++x3xVz9igJHxaWyJLo+hpMD3GlSx8n1mE2e1bffYt+yVR/55g
uoHp/roOyzdEpw9TqwGqPbckUxzn2zBN1niEaUn1GU/fKLpPoyRC7h3nEfg2yZav7YfFVsOLvpSL
xXS+1pRRXgytyrPkHW16TKdOEi+19g7hgehYpk0R0jFEqPJanceCphvND8FNoJ3xHQORC9ARo9pO
/MFJ5jtFb753MRMhSSLJTK3FHOgFtr8K3CtQi+dLyUxOGzKmpUGZuYdlwk0e9fAxMw9eAN+PRNG1
pXRslcjQIiDQxTaGPB6g2FNC3e8Aiej6PcMUu+uGsWy8aBinEgTDaOa2D2A91/1h2IXPyYHh2/w3
7JuavmNRGFOxc+HmGiYmE+3C1Hw13zmgo6X3NLVe12JtnVwepJTgKFL97Dg59TJOEJjjbEWzD9Qa
cA/Uvh2JEqsSsGXK3Racx6LFKYlSRnNezCDILVSHyebHdQ3WnADVJ4vEAWEQWpxb1aRlRgtC5uRb
bbLX8vcBQ5pK/xvLdCpkUfLkXozBRDW1tpz8OdhAnKrrv+GJT78vHo1smhlARAkjvGtVcNJ21xdp
zVhPvy8YazbpgZUcua+YFHkGem1j6Z8g0diXhsRdru02JQJy9TwqwI4W4kVDD4JqSPvJpy1xD4Mn
J/t2VUjOOaAzLHQWF5kUYqyRAeeBPlU9PTA+/t5owZsZrT2tKZLn8drzXMdwTcMAq+EyfcKwgJFZ
RjX4YwA1KaRrGsS1oNCZRxdQfOCDtiDkNltHqdtDZZbep64Zq1dwRpX7kXz4durVUYYBvrKVZ79J
2MrJUumFaflN1REgsPxHr7xU+rOrSt5UazfFmRzhco1H4FWYBBt8AxjHMf2kJm8hMJRj+bFyP/XK
fmjfTCDtrtvpwjojetWFgpMkrEtR+aKmbGnkXus07P3UMDeOR0mxBuhp51RgStwtsxSMdNCq/WrO
H2ujlEhfuet1yoBkIJdeJyZxz0+54mWDp0Cz7Wvef2ja34B/d3T3x+JdYEmuwtVNhISU0ixxBeHF
uaSG2Ry6A4+9P+v/Zi4k6JqxKScggMqb++kcnbeqbS6VR5Un/7kgIDjmztK63h9q2HFBUZU4rhXv
C4EN15NLx+BlWsQxKsUFl3fwO+YmeendzQzk1oasnL0mhnb0BUSA9MtF6KACeFhUZjX6zOXlMYSa
L5rhXzc9mQjhXNV1DM1oh4iR8Wx63rVHR5ZBkIkQjpSR6FMzwuDlG8phit+NzUaTmfCK/yUNgldc
Er40igr7HeUzIC1I8c27RN25yvb6Ikk+/9NpnNyDEaBlpWrw+eGzaz636e3PqtNf/7MQePJ5c8E1
DvCh3OX7RHl3hABkkNzkayfvZIF+OqATEWoR0itOYc8PPwPqw5A1aJ8Q2v/ZMgnHe55hd2yievQ7
h/lG8E2Sf/5MwLJPJ1rEzGnDGIkW5vhN+Z4d//2Nzzs0j9DSQX+P6J6itjTdpuBUg6acdRBcA/X3
ZxIEBXTgi+FfR0JcbvUHI93/zueXdwZPnCXpeL4+TFCaxzlqBr+cKzCl8q2sVrV2VdAJ+78CHOGc
VW7Wu2bA7eg6z8DojHS/hHO+Yw60cCVcGatRCGTsZPno8nXoyz5XBlbT2WPGo/Oz2oeoNuwfjOTN
K+96/al1jH2r38HdtYPtAayzTeJ8vr6UK6+2JQDC+cIGQpOeoGkZGrSo63Hl67C4w6oO1FW3Xdxk
BHRhSNZAtncrS0tGEw8GyRFZY7H70Z4SsGE0r/S1nEH74N6M3iv1CJ4Gs/y2IbHD5dcLr7gzYYv2
Jwepgk85zA23hH0WeHQYSLqD0nwKsx9p9OaAK2ozvX37ep6qJ6xnRojTRXFQ+sEx+6thJq+LmKts
pkeDodZKmTb6PEiuthWvTf5o6eZ3mC0AiORcyRj+bviCtdI/gl/04zaGtyVSWrJTv74unDWjV3SY
e/l6/yEbP0/Og5beece366u21gNyJkVwqc3gHc3aQMo03Q+gXJjxlyaMd533b00PteeBlHkXNI+N
mUksRLZ4gqey6hHI1hHBZbftSPX9xpV6ptgSNJxYoAIfdT6DGu/TdNAyry2r9Cz/v2jhrklcS1SA
OxQzIQHgSS1V9cK33K9x9aS7j3X6/frmrC2Ra/I+onECtB2RkywDhyk2oqz0syeFadxRcmJknxfM
V3USg37dvPTVicGpv/pOVoRYFWAx0kBRh+EXkeuoG1QAEBSj8KHs8ZqPASCG1xdozaUxm+MR3JAE
4W18vsfHqTF6KO9rPy6Kd2OcMDDaMFwM9HID13U5SB7hKzGOufQawN4KV+BF/zi56SM0B8xp9O6L
UoANUGS7TvUdydtixbIsWgFN6mG8LC5GhTKQx8KyOVZ+/G9Yb5q/Ddm+rFw9lqFxEdjwWUPlJZx5
Mmyz0oKd4WdJCs+8Yj4WQ7pPuu4weIBywS2UAlV3fatWbOFM5vL3k+OYunAjBm5e+VX+TwCGN3iX
fyhBOPC55oBxN6BVOQUbNz8wky2RsGJuZzos9nGiQz64RZdU6JCCbBXFhw4q0/qOgQGAga+v1poJ
kF1dJoK4rnVx+KhxFQcw/rDyrdF3W8CRN511d13EWiICOsX/yrDE7j+lryDP5sKsm4e2gfFEeQPV
BXCkj2bwIe8/JtVHS5fd0qtmwMOZdIANMr3YeaoWvZ3Ojk5cwNite2e0u+taSb4vNp3GLVPcZc33
M/e9aeya8Z/r319xASC3/ff3e4LHifq41uzQLP2oXQpUugtc5hOL9WdS9HNDC6O+GMLYQAogTtGD
qe8AmwlsSbJEtlaCGwA0tMo6F136vv2rMoqnoEwkr0KZiOXvJyeG6m31/5cLmLmG8nArucJk2yGc
+VixG7MwWKi5oW4EPdAjnCyz7DTKtBDOPfPGrVqpSHHCOxAd9XJ3fbtl31/8zskqdUUHdG64hEI8
PZkwDLsnMDybz9elrHqvE9MVQvK6KYEazdEirUB0eNKVl1g9JMnHRNbS85P1VQiNzg6JEIqDLkcT
Zc4h9KgOxWFyBwNYBvBdu9ON2ATjMij3c6qDgpE+uEq30b3mCzCt95VSPA19qMMx6Hy9rvx1Q6FL
9HyJkwIYkOTIEhf5PjpuF4q0r4w/XheylmU9UZxZ43MpcwWUfJZyooJOA1bKVEAIKsNulzbxsIlK
AKoJ915SNnsfgwe6cWN33HSetZDYhZPEwa9bFW8IU4cFmBLR+Y/RItsDgI33XlAf0uKgyPqr197P
aPtLgGBQgEJqMzF86QOu/eKAoxGbyp0bO5uq0famnoAR6B360Xoc0FKPvAM5zLu6Uj9dX/X1rf31
MwRrA1ABxHyLe6zonpw+2uRAJ9PRzAPakezv+gn6rySxXx7KWvAXwYsGhvfzHL0r1I/H6L4I30kn
tFav/18rKz4sPSeoO+CL8cyQEVS0qW04FNdXbf36P5Eh3DFpkIKbdOSFXhUTLRBvdvFc5c+x+t4s
n2r1bgi/T9G0vy5UptdisieOLtRBiiPBw+3vPRnNc+7yOP+tq/PXHgk3gtNWtl4vIhRD22tAWFh2
+DAVzaEenMN1bf6P4/5L1mKZJ+qAwEyrRGVxTUfPrf4jN98c5/MQ1Bu1BZ6j/LvX37zpW2bdmZ7M
FCVGbwuH22nCPusNLKTR7pr2oHpvx2CfdhINV/fLol9S1TWycmKThpIZAAm3M/sFLkr8iRfCVnL1
LYfz4qo4kSDoATKWnuQhV4VVP3jdvVlsrfI1VaBU3ofaOzhMrm/Zqk88ESe4LKOvvc52Bu5ASIeA
C7l9AHFpKvi1YIIvKjMgsWOAjvwqvfvSyjy6ZLHEfADNF6k6aSxWpAEIvak/xuE/sEk4xVO4/Z1O
j1NVDOEuy5y414xFFXC/mUULN5HEb0uMS2TqrjLNbOxu4qRmhy6kVfrD2D/80XaLPQxp1o9R0rFg
RT1tXnqYSK5/f10Fkwyi5jJPLjYWlXqeADvFfW/U90EPKKF7F86y3qJ1m/0lRHCa1lh4RtYuMW59
PyUfB+t3YnTr1/cFj9lrUE8eC74/WQcrfsh/Y0gTQ/r1fcFLNkwbckezSFrzKVUeneirHt45+fyH
eyF4EsejVgD0FcsU7gH8PNrEVBIRq/f/wvYOhItBb61wZQbU0YAAIWXvjntl+DeFaiRhHsj5VhC2
X7esVf9+Ikp4m/VUZmOgtis/TO4n80vb/9UxrN84kifgugH/0kiwraOjRWALE9E04V92AUPKuzSV
3CGyRRPMS++OSXq0CUOH9qly97T2b8zoMYCTxPZ+y6P80kawtAUH3FZ/Zk3giK0o22yV4Xf2xTZt
y9T452IgJx9KZeR5g4OvwP42ntzj+6J6b3cSDJW1M8/Ag0VRgV6fi4Gc0ckL8KRHnG+078Y7Vbbv
q9HfqQDBlB1v9rIk4CLs6qc0/94Vd5nTAR740jqfrOZvB3qiopcotWbTpzIFm65MQwd8tS992zpA
YhikB93Z5/WX6ydnzd5OpQgmTZUnSoF5K31d+VJNd0lOT/ch1nazDCVCpo5g2HlrJ3UDkqdfeoGf
t8NjVdUHkNthOzhOkqh2iUvEMOlUKcGyHQdinwKwXt+CLy/dBunjPO71cTeoH1397foCyvRaFvgk
qtVGoG3nHr2gg51iGpjv5/F9Ov5GkvtUIyESO3ZqY0wZFs5ollPCqUkSVfLEWVcEZohlaHsB8RIU
qdTRS11uhM62n6yyfNHchbo12oMt9RvdY5bJ4M//yBLzjkUHb4y2REv1Q3iv0tEMGZCk+rDuE36J
EAIyBQwZHX6y0nfzO619ds3fiANOVRBcAtCY2QwpK8ESID9q9Z8G9tHrliXTQHAA89iOXRIhwfGN
eaN9/bOvCwe/o0uKzgfiyby4sxtA3X/D9Z+uj3DeuzxMAYNczEm9V7rPdvqxLr/HkaQrYfnK5Un/
tcvCSbciu0t0Wy39sPiYp5/V+AVG9j9bKOGAx5Pj0LLK0RtheITgwb/++dX03+lCCUfbUoO09wK2
uUvTHQREoM9/jmhxPJbvlPyjOeaQI1qgvX43x8defx95/8DCmkOcdf13yKxNOP5FA/yFE3IkOzoq
YGRUa4mi1/0LTWHn/iUsS3iWlweMrn0azfs4P0A5qCWf/0QN+tXPpQSEZ3ORIwVSCMe4NyZJCHh9
mZjEOP++Blt1Vpe8kfSKwYiHTNYpuWrQBp3F9DE6ri3msphUst2srHnm5T3NrsbGHWErL/Xf2e0T
MYIaRazpk21wazX1xzr+AlPlHwoQnFc86UkFAghxbMld1f5jF3/9xkafaCD4r9lth7Yf0SAfd9oM
CdD2+vdXzRXoM9Wjx5vxaMF/9VpCMxSAL/T/QFmwyew7DZjVQRKDy6Qsfz+JHnTFJdfdLBchYwmj
th+sr/C8bTJHVkmUCRK8mAdfUR8FLFcYjpsmfDWPr71pQr73+fqyrZ4PwgfT4hVrGeKM7QR5mjMn
uP0Z8OvExH5pn7ouYvWI/FcEzRLna1akahYHYHj7qkdqBzzlL7UsWX9di4v5AUj6ApAXOeXW3/Dk
tf9cV0D2deHwBfAAj+PEE78NX2iVSyWOVvZ54ejVSm3CMcYWKM7d0biXprpWTelk/Rf5JzYbtIZe
xw42u/BIHYqvnwxZZUi2w8LZC8s+r+ylLG3BaJ48U80tZLfR+iKBuOmYgA5oYnJQnVpaiCyUoDKd
QhYmLRis6sABcD2TtnR8+fkqVQSgeZZW5InAb65AELSHd7H9PETaQYu9jRH3sA6+OO332XpMg6eS
ub7Ee6L38XdOy8nvEO51Y2irrOlLfkfwcWoPdvMX/R6327MLkCg3FpCiF6flmATt0eqHnEYf7d7L
jjuzkZyYtcU8lSCcmCKY89Hr+tyfjX9D2B6qBwNwiutaXMgAA5kmTEt3YKIAf0c4NlYW6EM/NcVb
WirxfQSU+TuyPc5DOdme5G7Rls0/C1t/yrI88mJ07160Qo4pEGdZMRdveaNDBc1Qz7gFt2TX5fdd
89RlBiy4EK5NC2Vf+pJNH+KsvNfi45OZlpvA0bdNnNKdrkqW4CIZwM+yiTroLjIWgAlhCeqsmyel
7Ku3sIEa0G73SvJa0NirJf+0ruRFe+FFBFmCF8n62q0cqFneXPdL5KXQCsNnneibeI4lWq1t7KlW
y99P/NWk2mlVUdt9s8NgP0GfgqnuB+nQ0OriuUwA8h6mA1GcecCl51ZXVNVbYv5QSnjStQ8xREsT
tOrHItxdN9YL98XqMY6Nmdr810UzdgVfBZwSU/mW2sVnq43f9WkkMVKZCOHMAVlsmwrFn7egLb6n
CtwrQSDJ06yIAPTFMhj4NJiR/fk0OtkZc+orS8mP5VubqtvyC6wgEh1WjOxMwPL3EwEUHHRNSYry
TU+CTTo84jUO4wC7rOzOvSxuApZyqooQX4UUHZjcSdmQ+YOlRSCfthvwRjYZxEZzAXOaBlFouzOy
6K7zkk1a31qqc2noVOFaBdeEf8UJq8oqnL6IhuLNmCHxQtlOlbx8Vux7aXh3AQ+kfxRs7PO1dPJS
s6Y6Kt/GMbjrE33cBMO86RX4NvLGCjZFk0okrpjHMuyumeSJ6PQQgb5dxQ2jJEDiUdG5ob+Psuh7
TYC9QNyYP4ePxVFwp6cQk1hW8da136ao2vewV14/pysG6AF5BSyKS0rNFhetTaG7Ybi5eLN47qqf
Njst/nxdwnJ/C1cJEjywJBz+vYArgzmiT8dCLd5iK9+a1bCx47+PVvOuzcatNthbzd2Pk+Ttta7V
L5mCa0jH1sgY/OKqHBn+NF9a9TXWjltrvLuu26qcBXkCi4NZwF3+fnJ8877sQFboMGpan4YRSuAw
oTVuKOHMzgGzvP2i8AAnW7qVmftkzuVcXNR0WQZyYPo2DxXllmw/0JFUQah8Xas1qyPm5KyCxalS
CD0Xo3TpUfECL4Gj8WHaFbIhRdnnhc3Rw2iGhMRJ3kq45T7Ullk+OrY0vXd5qf5sunYNyrg2bdGC
EtDE6NAputFbOyycM8e9rZv7WpOhol4GSoyL2szhwk/hgFwnbEltjIXt6GP7xvzXLjHup/SbEz1a
1jvVOxyz77duDM7Aotl2gb4AlkLw4Y2dd7MN99vbNIXbjp7rWHIdXbpQm1hPU0lbQPNNWex853un
6LphVkr6XMyDNXwusqfEBGto/uYMX2/W5UyUcHTGIS7bunTKt9yGZnoDJ8tvfJ/dB/SbgYKLWn5o
ZOCp0Q37tlBSwTBlZ5umPkrW6/L8YzVAqjBC6hIgiPBgmFUytWrbvbURHEgHG+qycOvK4O8uDwyI
yMsI9DLZS1QjvJAaWgu1eJijtyAY9Gd40/K95calJFN9KcUhlUQzNMEOgAFiN5zFI2yuIXJ+DevW
2sGpUDfm7tY9ORchnElXjZRBA6zn1Ype8tFv7v/s84JjCZR0qlpwHF/Ln1abpTfPOPF+ZFzEWyq4
S8VYOB7m0cr7sa3c16Cv9tNz2Jj7mzU4EyAcCtsAmbQOa/cVHvoNLEqb8daaraCB4EFqAxgiXhvu
K9zLO7p1Nn97OXHSfDOMLrGevrw1YJDRbEbSzx1JnA7qdCzd/O04QcEWpRtjIt+t326z52IEg5rg
zJzAO8rf9LsqgnFZlQGCXB4KuuQY2yHByoOTTMm5Hsakq3M9eOkbw78b975XZQ0Ii8mcR0eLgCUT
yQkn0BN33AqC1OiU9M3KPjC0lWjf4s6/blSXTor7AkhtkCuXIQ3xOj82WpGn0LixFy3jr9vC3LbR
vvRSiTNcWaszOcLxS7Qgg/YdOYHlbcr/xIkMcVQmQNgMN3WaspkQAHv9fhrNrRbfWpMFStIk50ED
GKBPVDfOtzsNK2PSent4BUmMp/LOnWVYYhf7jQRLXWbFlwvjgoYod71idLNhfDW7XRtCZ7YfaklQ
erFM5yLEs8dLKznaCSI0CnMfPBn4wIU5CZ8XzlzSBk7oDnw+0B67fwP4ut3yEabP60a7qgQe1lxQ
sFQIvc53IrPS3IbYYnyNHxUVSnCm668LWFNjeYZS2cRTXUzljSpcpLEx96/Tp95+6IO3YPrSRRJ7
uhzH5abARTFXuox8XsxHHREfQBapA0DAjTFY7/K+2sIu+XHu2r0NvrGiBAdzMv8tGNVSFdmFe1m7
/SnfIl8G7siCK3W+jMdqDhO3ynXQOrJNaWk7w7jPpmlLCW87mI9l9L6fnuI23GrTHeS0EKTe2+0L
rNq3LvayDKy29ZMZQXy4ZFXEAzDpdd+BU7wF0rmJsp3DvN1xvDUGWBTWeHDqHjEZOMvnClfMJKhR
Nem+9UXt71Xr1iyG8PnFbE8efDBOwoNR8nljGPe01UdtJTm96yaDvYAOpZLuFTGirUppXLey0GDg
gTcUm4Ix7iDemx6zCXtahUtYkwdnU0rnIS59E2t3Inl565woF8xDamSzqfuN+ljP74fwnRt/um4I
l8caEbyTUU9foPsEe2TYsuqKSNf9GNpLZ5vOErdxeaoZruZIc9tR+gb8+lwFQEuCsCRkp6ixb6v7
7F1TwXwguehW1gmcZnKbqLCA5glKmIFiwHZ7NH2lHh5ipX+KjfF9Vc2H62t1kThZEPaZs3Z5W8CN
JIb9aR2prabWJk1iXzvzwTL+bRmHCbwPjX7IKhqSVNkg8cru0POkMafMMWXKSFCsaufj0Tsall9A
Q13rn8ZKkk9d2R5yWTqugHcmFQzBwubaqccqiGy/iT4N/bwpvtW0dJbW6/WVW9EDf7sgHZugKGqm
oIcFmbJTZIrl995BV7aGRAvZ5wUtUt2rSNry+Ub9ZJF9SWdJ6WFNANzgFKhBEwE9Vbhi68qLazUI
LN+ui80PJ5X1PqwY8JLxU5l+X4op4j6nXtDXxy6z/XR8q+MAvAZt5zmSu29FCQtqJY6jpTPRL5IH
eDl8zUox2r5KJ71XbLPwx8277BAdYFCqDjq8tfyAE3c1wcWtjUPl+KZ26KKdKQNEXlGAHAirr3oL
NYBYLznq6mBEpPL8nFkcyor7ZH+rAgZJeWDNcIeMMIrOyu68KhtBAPWNYNcct1V282V19v2LQDDg
ooKn2/NV7V37T1ZI/NPlYYYzi+aT5RzrsIQK63/0hsZpbS3whzzeVN787I3Ns9N/c2TENpfmei5o
+fvJRpu1G/Wgswd+Eu6LR2XcJzfHguRwOG46YK/GJeLqqDtRH1YZTSfecaslX23zLew3WqNKLo5L
iyIVhQyeGIBbXED2tAxPa4lZhq+zuT0G7yLTv9mg+D4VNx1WFnAlhYXKylGvmq4NX0kMpv19IgMF
W/v9RFUkcciDcLCF29UdWKTCiMNXZTi+WO34mAIsKdkLiQzRaI9g5IQNhHavE/O0g3rw4I2/dZXo
TOc97zoWp5qw+NycvDzxlKOnuX67o/e6lVnr4v3PXvRkCU4/vxybE2s19PgYkRRx/SndD/q4NXJ1
a3TPreFsA0Pbhrc/95BHNGJoJvHuBXdJG8Zl1euxB+Sye7Bb7yDx45en7/z7gj62N2fNsQzQZ4Yu
Zxd079Xb77tzEeJ9PWW5oaWI0O2D0m5K/eH6ji//v7glCyz1AkRm2Bf3aTCPTTg7qeLr8wjlAHFn
ce+G90Pw7AXhzREueaITWUIWZIzTrB4nZLnNC1lh7yjrFrg8IAz9k0Sw4EeClVfk4w2c3vFKxQp8
93MCPL8a3YyNuBBbL681WjlX4D3V0ITvxGkDv3ksTG8/G8P++nasnJAzAYuGJyekpqmiqYMm8LUk
vQs75xHOGCvf1frO1tv7wHAlB37Fgs/kCQfeVsYss1MUyiz1R5R293GU309Z9s91tdY2xqTnQFt4
wcGfEw5KN1bHOs5RK8k+gb5hS1K3q5+Hh4R3DZZ8ARCd5GZMr0AZwJzw9cjw/fHmsh/7TnMRyEuQ
lRJVCVHnEGtNZbvHwK97GqUOlX5zVAujOESb1DGA3blIfcVmN3V241m+Ue96bZtlu+vrv7bNvJSW
hDNY9xd5zr6g7yAsbdPPwuNzamZPutHdhZV3a9F/eZKdiBEPeFQXQ8fzEJydnfq3KhtKXKxE8FVn
nxcSGBYg4yAceqZ/BJKxitPt7CTb0OKikgEIrq4XiAF4K5cCqVjsa0GLSooksZhJnL+rqfe+YTCo
TZK769uyZreuTV7V4CVLV4bg3Puy7Rywrm1f69ttUxyGzPmdjffIcC2FmaWR6tyfgFsRl8ArYVjz
DClPBZbofpI5kVU1ToQIaphqnplDjxDwmCnNfMpjSY5MJkB4VZbJ0U3DEAHdlDNNkWx+I1AgQvi1
TEL0pjYFwxvLMoEktvPeO97t75kFfwxc6qU6TdZW8LNqkSVmFDiGbxTzwxAr+7mUvLxXTPZMgrDT
utl3wUKg5AfKl6nZ19n97aaEczXwUsD0abQRCaZUZKWutrHth8H4oEAmUIzVRu8PNx8J2BZMhijo
YwRhQLAlvYkXTO/A9svoyfwA19ztnycDCqUDiFxUG4TiW243wdjrR9sfks/uB8X48hufp4WQPM7S
PCzeE1GhFcehw45IFxvf4un79c+vOEBHo7XTW9qFvIsez9Dw8mwuFcW3v9lWv9Uye1ta07bwZGX1
y6FZmsR0jet6geCnf0tYp0Jzsnm2OsVX43mvDvvj8Z1aPcfjXaylW8fYqSTE3UJyfayY8E/UdJLU
HgQijiB01mtVqdLZ84fwS2Vbe7Ms77Pw5ocgDWPEbv8rRLjKQ0OFem0RcrQ+FIfs5tZYsIJZODoi
F0z2C/udDFWJZtB2fSeFC6+r36eRum/6/D2ArpIn83IUhOuQ3gdaeWixcRjTFo5KOtTpHHeB58/M
yzved9t+CbIH43OiyRriVzZmMWeQlTSL6pxYKlHtuK25XAjc++mu5h2l1YyxNfrddfO+dPOgE9sL
CCgIl0ysCU4SUPCoNoOpfY3sZvMyqDLOzrXvmxrs2XS+0JkoZq1GxbLmos/b16PxI7+zyr9v//kL
9yjunaYUUK/PHWQHK844Ht3m1Rs/utFWK/7w+4IDDsq5MOqG74fu1nm7mfrVsyGKWdad38/bSbg/
Bm8e5zHwwrdJfaitQ3PzFQ7mPkvP839pRBXX3ssDOpqcuH7t7x0733u1DHDpcnN/hudE6aZGVlUs
5Sv6FJDuzqtXOuy9aK8GN2cMz78vxLatGtqBaWUVkD3p+3wTHyuJgMtDxsoDqEC6juy2Lpbn3FQL
Z/fYlq+FV/6n7aat1y+zAua361Z6eYfg0BcHRZ8kJRSxqzViikA99lnz2gxfU9PYTvQABzQM5JWs
4HS5Iz+vDtsBHc6jA2z5+8lb1qvraLDKluPc31XeppIhIsq+L7iLuOmV2Gj5vhHuRmcT/7i+ULLP
CwditFzIGoemfVWoAVvfYPHa3CyAhkWT155Fqv6Cq8semrIKXLV9zQEOrx80mOlvF8DlzWDPzxMh
1kqKY2/G89Rkr0n+V7s/3szLSgTCaaMUywzDQtt7vr+z7U52XpbJa+fuGtgWJLfBynk4+7yw/nGo
IL/g87vM+lY9HLuvN6/O2feF6zPLGyNQBr6vAwTzn9KNDte/v/b7LY9Aw15IsUg+ny/PNGn6PCtp
8ppFe3O604L9qEvyj5fZInrWNHofl+5a3pHCjdB5uRvOapLQsvbqxsW2raNtm4Bz7Do0AR03g2yw
duVM0DdKmzVeCkYY8V1s9kVWz26UvKqDujlGD3X/en3RLgV4gM1QOeapQnFS7BodmoDpVMViwDX9
FGzM9uZH0vnnF/EnLmmK04RED5+fk/FgjdOm0FqoWmzJ1su0EE4GJ74pSCwcX6tNkewgH7q+SIvl
nwd+51oIJ2MGz5CHDJ/PzGljmZ+V/dT9Ra/vze6DLCoVdt5KROPUQs8Xi94/ICzibHyti3LjZPGm
llxFK8u01PgY4SQjeNlnVGSwDHb62L3aW7P7lOk3R/oLgw0lUJhteVGIb+5GgW2+z9XhVYufitzb
RuHx9n1eHhN0bKgLIaIYF1PNqKep8abXOH4M7yLv5qzg8pj49XkhoIySMYzCns/r9pcuf7X3183o
0kERhwGwwYwGpHpExOf7W5dTpVh2ob4CXq88FqqWb0h1uXQhtbUU51Pca4q4cB7zorQtnOEFq5CZ
8e7KK2N+rbSHj5l2f10V8UT8/DrhHQThZO2Ibs5VsbVpmJOyml/dfHI/AFxfvmhK1tzZlQqJc5YG
1fa6wEt1UMUFZ2Wpr9O2I6xd5zozcxrx8BL9Vbj78P+Rdl3LcSPJ9osqAt68AmhDT1CiROkFoZEp
mDIoeODr7wF3751uNKIR1N3ZeWIMsrNMVpqTJ9VGJHypz/nnF29HCuR8nlf4vDlilFTzZlhoON6n
W8WfLS0Wy1ZoaaVTG2I6Kyy9YPI3TtjW9+e/n5hbBBzUrzN8X/gog493NduIKpZHGJ4loLu4e0Ah
o3tuWXXVE0TX3dB3L7r6rPuRp+GSxx/e6VMRy0wINVNSVEhvvuhGUKkw3fByVpZonhqBdht/vobL
zuXcN1tVmLx7abWDJ+79rZLr2veBY0DRYgYKANV5vgUtqXTZZGn3ggwnmOLy4OPLA4TGe4+fidug
L1wQA1RKnokhAS9zU2GGXmD+8/r6z27Y6WOHLUZZB8E6Hn4LAKzFGW2yrs5swCde7PKGJOgCDRLv
Bm9dQT5fF7SyUqYGOD4SBOCQRgbyfKUADGa40UnzkjlBQiN9w/XY+vz895O7ULgepqqV+HzPvpL+
u/VRUoT3dTr5+fNVOf3+mHWi7/F9TfumVy/5y/XVWbFIgDcgJ4sM+Ny9vPCWiWPX3liI9gXELd9V
We/dngSkdfeYQbDhd6xc6jNRi2ePm9xEMYG3L5na690vxnaypRsyttRZHFtpd9JxBqijp1GSR4Tt
fBWQbONyL/3z9z35d9GWtgNTOrIKjfLty1D1QSZJANaeYLLrMM/+6OqmybbUWrsscPTmjUJXw0Vn
3+iUGNZIq/ylpG7yXfcGDIRMy8K6SVky3g25Gm+Z3rMt+oULLDUUnWkqAMr7DyvcYjlJmQN/Ubr5
S1UV1hOmmjsJXhPhgjijx1wX1//TN2m7T5ij7kssfRoI0ox1MHhOvydVizl6ST4JDDKp+b6yXbrx
TrzD9hZWBP6qhmQ2XEJg2hfvtc8UZ3nKixfVlOrgolcUw9Ab3bktRW/uRgMcrY1ngdRQDe1ReWjH
ZbpO9xi08g1YSu13xyaMpCIleRAI2YOc+QVQmlz9vn7LVo7+2c9cWGsdbUGJQkvKSz2mj60lfhMM
xDA69+a6mBVbhBlLsNrgqMJ8NG8hJs+bwR8NWAkjdvXdh+dR4TS4mOcyt8gCvOIvHcspa2xnqIzq
pdmT5LNfvnz816NqCiwR+gYui7OpoXNl1ap6YV1os8juw49/H6VAeBR4NBH3LEwd7ztXU11Rv1jZ
XX5s+V8s/unnF+YtyWtbmjU+P9qfbf5VbeQEVvZ2ZluZ6wIAKlx0RI48I01GtPqlMiMv31F3I025
8f1lkUbVRGRpgu/3RWQlQb/hT6zcgNOf7y4uqmiyUvagcnmx6vqGtZhV6DfhOLkfDhh0eIuai7gT
OWnnvf518lrmqhobqdnVi7CPU2YHU/WS2VXo5/986CwBQ4dThNgWYRyIhNDXdP4qu0K3VD4YZTzw
Mmzx78ZyLXbj/fvvmR/Uf0z3ouA41ghPhJZX8ZiCbikaxvxjl+E/ApC8msNQD0jixWnVSEZSG3WZ
+KFwVcTw78cXCOS/DrqRHTwf7y0fJxvBdOm7Pa+wQK5xbJt0b+ob923x1L9rcCphYewaV+mVR7sy
njD7mbpGlOoU493/kVvwlLW98FF6QO1yNqtLVz5FrhVck5aK6Q+VHv1y//GVQrLEmYNOVLG0hVly
SUe10XFUXMsv48zF/cEWh/eFOhWw2Oq8L8o2NSHAAuuqdkg+VnqfP4+nFxYbOK25uLe4ClaruOUo
UsZ1Vv0x6/azNMRG2LyyA6haIxUKXwRQreUrj86tyeiR043NNizdYNgKplaO0tn3F0ep1rU2bRi+
36f1TUH617xEZ3uSHZmxNR12S5XFaplDPSZgLC9jYH3RWau/Xj9MCzM7b8aZJrP4k2sn28mQFcGl
cKsj8TC656HcgjKuagBo01xrnwEXCw1IVvG0ob6MLUcilTs5IUEAtGGeVncEtSygIWbajyXxMXdb
Ip1EYkcstUPb4vfasvZtw3dJyT/28P1nyeB3oFcQgTQY5s6XTB/c1MkMr4zz4n46tsVGsm91R04+
v7h9jqZSA+zN+Hxd3LjADIBQsio2bOHqnpwI8Rc6OGjSB6tZGQu+99j+gyD45RJ5CwCHlpFesdwt
Y0cARxyQrYzl2m7DJ0OpCZgHYJUXW2AkTVmkEkdKiS57HGrjN8mS7LkpqHZjmf208bjOS34SNLyr
Y2IgDNwEpIAuLJZEQ/VgUkvGiJj0h6lBt5wBvt+Aj60b6nisoqTIvO/MzIwtqP/aaYCDPvvPiFou
ArmKaBOGSGZlTOo3MjSRK1+aj07Q/q9+/wpZmLOhSj1wW+Vl7Dc7JQO0g103Mmun7VSJhQVIyVT1
ng0lQN4Q2d1LUW1NRV1dJmOmzpqzsRfAlIzzjnPqyRjx2/itxETUDf9tXQBmmM/sHHMkf35hXLNk
I+8mGWNG1b09lrdeI+9VIj5dX6nVkwZw3v+KWZjjAkMwUIUcZAwvDANqD5NjhMPQBiN9tPRvWfrt
urjVjZn9OdQt0L+1nO4hQNuEdD+06jGmEEMmAqP+G4VOJCzWLZG2pupak7EuvCMmMIS681TTMhzc
Z8vLg4y/XddodZ/mrkZUo4G6WlKC1tTOqeaUMp4wjM01pj9jr1Q4JWTDgM4W5sIknMhZhCfZoGRp
o083dg3MEmNG5+z0Gt6YGFoTXbsNeeFTzzdCunXlEMrBP4YDuOwMtrtCddTB6egBEVCHNrml7Ybn
tCVi8fpkSuolaSDCz0jg3NLPeflXd3UGIYOpB+7fsgPLHpzObCoi49x+Ed1vH3DCcnf9FKzuzomI
+f048WpKPnHSlmkZSzmFhR1nYNl0HPQ1/NLz6OOi8FICBotcMbBv84KeiBIJBjGwKhFxm/qhIdlD
wmWEsm0doE38q87tLd9zbYcseLVo1/DRibck7TIFuB6s0RWxIXWMVMx2uUyDutgCFW6JWb4JMNl6
isRlTIxfuezR1vTTNjbqvmvbdKrKwjjwSY6qsjzI0MFnjRmjNoszDCgDxmrnTC/XN2rNZzgVtjCt
hE5cUgaFfOyNVX2xQbHQGRIO4sYVWjOq4HEEocxM/Q4ex/MToRkcPb8albEh7Dti0nszTTdErG0O
KvEgbcM/K9kE6ow5zXAGCl8G5vg0kS+tv7++XmtqnMpYrFel9yTBqHERg5sdqX2qB9e/v6XD/PeT
i2OPjoUmQHyfZCKopzry0QNdWxt2em3XUQwBJbCJkByg1XMpHUAsCgl+HuuDcSDWU9Vg8Ar/KY3d
dW1WVwt8V4jKZ8zn0gzUSZaBM6DgcYIZs/ZNsjXqa1UPBxYGBCHvdvNcD5P3tZ+B3C7WpkPDyqBN
ZVCxw6/rWqy5H8BmojELBUggMhZ+tZUOdHBLKWMyiTAtj+303VS3XdpFLrB1Vr1Vplim4989Txxj
tPvO1XoApc/VkqbLqsphMh5ye7pziT2FOUHCUht0cgAri3V0uu410ZTclYY97qjp5LsOvUVBJWUb
6MoZw9E0q8DIiAwzw5e3CYBL0fVlWTuqMzQCyVT0EoLe5PxXumA76sfGh8kVXwoDlRvnzWj/4m0/
lbGwt05bakTXiIg1IyYKlI8Im7YyR6vbe6LHYrUnfxSU+7BMtQ8+SaN/cc3pVRrmrcrLCFRlKrAQ
0/7/1m5hRrhudKz3sHbVG3cfKx516m8koJKDGAmo5Qu8LGhOJldXCAYxMyRU3U3a/SPGrWFHq0fg
RMhCjYF7kzuOiYw7UYYWAYrBRj0r//wXiwXvDmTKoBWHR744aATEWrxzsEESvOXTYTIQX26ODVx7
duF8gcILWTjkvheWF/gYs+1HFz5eJ6Mp+5zIA/erYFSfU/brukLzsizd5FNRs1k7MfI5CFR0B6mZ
eBi+9N2jufH5tV2BaUcjz8zVfVG/coXN3CIxZdxQdk89Y6/39Iak3sdK9u9WCpnKOXuF5rALAJmb
qKx0ugl30yrzQGrkmXjeP9dXam1TAL0Cxg5OCrqeFqa3nNEIZCpkDOvFm72f7rX0YIKB6oPsarMy
YD/Avs9l4dnqnm9JJakAOY9bxEXzk+U7pe8Ld2Nb5mO62PU5DYfmJPAf4P8LXXwJ4hfXJkXslH/6
5NiAe98nNOzFTVamke4/qXHDBqw8j2cSF2FLAQC7XeAQ4JwNQWE+KApCa2QaHW38uNsy17cdCxyX
YK1dFnLSDEjCrEDVtyE8GPJ9lakAQ52vH4ZVdcCYjQaVtS5Bk3N0uFYpiw36ZvPyUDjHvG4A/drK
za5cIGTIwXkIqj2AOaz5/p7cz7ZCAk22OAwW+eo6GFDmvTVqw8tflTHTJaHUPM8JXrw61HBKOqXY
G2EE4NE30yet//3x9ZoDfgd4FEwpXWZnHKkyz6sshrSJHXpFE2j6EGkF3KTNzrsVi4ZJZUgxAaqK
BhNzYaJJ3nRT1VYs9q2sflZO+13xRGCGs5ljRkjCyXMiEox6yPYkzqm1J8zeA2JihOBAJ8dm0vkb
+iSKnd9MdaDK3EF8Ook3nozZsZ+M4g8zU7X3J8N/KJzKvO06Oh68iVQ7u7TryCVo/wd6aYgxB0gE
FUgGDwWx8ggHqYsrlvcPXU+yqNJ645dkDblzSp3IYKpN/6dWttYQGsJrI7NtjWiaVP+nsfIqNMux
/11NWvZKuZ3/pFKCSS3J9FtbchJ5LesO6PF4zTvRBZJO9JgRZzpoMrX2jaM1YYdmN0S/nQz0xCqO
rMjE79YU2Y44uQqo42DwpeWQw/Vtv7SZKBHDkgBUj0LbBc2DxDjlImtFETNh7DT+xVb/eBN60jAH
19nq/F+V5SLdj4ZRAD3shdms0fjW2E1aIGvBu88OItfQhj+FbKmZJIc819x/pgRk4Nc1vLw76CEF
9TzsDTLPF5Y0zwbTH9wWd2eqwXJnUhWYvjxMvH69Lmg5+wDPwrmkhQXFwewqXx9YrJtqL4YiyDXv
vid+UDD7JsucyKHafpq8T5NjByXLXi2pf7r+G1aUBVDh3yVeuMBoDRN6wnOY1nQ4zhcidMxWD0H9
9sHpU7OyGBeAETHwTdBHu4zWKBuLokb3ZwzaODHUQd6/GM5GmWhFG0ToYDnBzuHILB+KfvBMTFrw
sziDWzJ1YDkxImsr0XVpjeD3nghZ2G+QjCKlnkMI/2F5Ksrhx394T8BNjCYMD53eQI7OWp48ENoo
NVa2Ko/LXkVNo30tR/Zg0Hbj/V7TA6ND3jtKgJ9fNrAA1tvWGTOgxxejfiXZxsla/TzQnOBkAqMs
sB7nWnhG1+CNwOfBfx06R6PYot1duz5wprDTGAaEjN+ym24YeT0Z2pDFAIGM98wgn3wd4yIqmNNQ
KbxG7iD/qdB4+uB0fbcTshG3HhofgILL9a0C/qWtmp0TwOxn2lbMllm8UShCi9ovjCIex895FzY0
EODHvH4w1lwUH2LmWSVIdC2f3Dq3CpalDS6rOmgkeBxIUG51fl1uGwRAAdQP0IwDJp/zbZMTRugp
Bhm8rHePmqh2H9UBxIF4d8DrgcEkF5sGDAURVg3vJxnl78nWd03Fvvapfs8Nd2O5LlVBax8gduAt
QbACarNzVWw5dFlXFhB1SNobslWOWDt/cz0UZHwzQOfCA5JSnxTTWyxVm2FoelojQlWTGVbgDZr6
5pbK4W6otO9ojr1nxXQwTPmm5Vtl5ctDMTcwuuDpxigTANkXj6RWiErjLg4eKufxkOVHrUOy1Zb1
0bPb8PrmzSt2HmScy1q8FvYgE9POzCJup2qP9q3ImW6KqdmX1YtXeQ/5lqu8uoPIugMuAQT6RfGl
byvXQpIGK9wl+5Lq953hHK6rtCoCmX2cSqBTLxpx9KLyGw9VnrjAKDGD/q6BE/sLCb49j8xDt5Wx
zGR1KUB7TW/m8bT3ndtqa7Dq2v6jhQGGdu5/x8NxfsopqQwgqoc85mn7xBgGJORFEmRu/hmdiBtB
+aosIADQ1AWQ/gU1Tw9248JXSR7nU97f8Moa9pVbD1HnDiJKfVXG15du5T2fIwygTVF5waNrnutW
dGPi+z28E8s4FB6AYyhR7K+LWNv/mf8JaWokfy5ogJxWObl0JUQM1N0DogaGdSPpNzKNK1LgxcJ2
o09jHtm1UESQUXn9YGXxYJCoG7qHtE9eryuycjeBi5lZL+C9XhbFxr7S1UjgljDzi+OkEdOsQ1rf
q9yP9NSISvPTdXkrewN5uJM41DM3xUKltHRYJ1yOs5BUL9yuHn2VHZuevl0Xs3LkAGhGI+FMHLFS
ekuGsW1KM4urpDqCR/l7KpMb8CXEWWt9uy5qVSNQNAN6PNMaL59XTJQVtszALQ2gpasB9vHYb81V
Wz0HJyLmv5+4dmp+XLUSm9T1uoxGYiJdAjz7xx8+JBn/VWRW9ERKNVRUo8qFG1wcDfPR/jjUCAHD
yffnPTv5Pm+6Stbo14knl0emNjzbkm5YmrWFmrHIcOPBNQym23MRtY02FAT5cE7FjldRvmFYLr01
UNDY88SqGat4AV2jZj1TGHpIKjZHw7kzvE9+9lUb7lzz4+Zlbn+F+4GA+TK7jIww8P5NkcbdRPad
7+9Mc6sPb22p4HqirA9VLumtbFU0/uwXxinYK4Lsn+uXYuvri71m/pg5NMPXAQWX4h7IuOvff899
LnwKrNC/P3/hcFZlPTK7nn++rqK5Vbio9ZDk406y4clJyRjwdvg9ds0DtYbXstxKAq+5ccB5gdsJ
dBAYA7hkR0FEwJqxVTSmhfFkd89l848g7ReD9UXQZCzMTfsgGn1n6vneofqnQv+L+3r6C5aA+AGc
W8oS+AW1Yz1rMnntMv8vkhoz7c47gBIUP4ttpA4m3PWVQWPNvx/IAwdo3d+4Uyvm04APij5BJDZh
rhe2LfUc5TLToXEGBht+O5m3JNk6LLODuTgsANXDJYDfjQ6XZVOXk9lFC4g2jQn3xTfD7RRg93oH
GG1D7pHLoQcL3WWBdBMS9j5ycKmy/MAdKbkpzGorllnV2ASwYMYoXnZ89aUEa9Zgp3GjPzP+Zqvf
dIuWa0kG9p4jgh2E6wD3EVmTxfWQXOuQNxFZDHv7CxXanym1wqL53ah2rzv8rhXVq1kYbZA2Sfrx
dwT4S/gs6LGeiXEWshuQTRRm4aWx12Xh8HUC+/71y7+6gCcCFhEaqcbJGhM3jcvpXi/uMTussj+M
fEf7B5onMK4aEMKLZEqr9Ymu1SXSEJPa9Y0egKXouhIrFhISUCqaO/8gaeEIeUUrmpp0WUzzPgkL
c9ACyfgWBGlLyuJ2NRgJL8oeUvLOCCwAdlplbGz3igcJRXxQi6BXBpnPRSTplx76QSqeIaOvajQU
j8gJ5VNX3U1TWhzHUh+ffI0akemC8ef6Gs7m5+Je+5iHiMQgHPFlJU5ZU+73FlI5RLW3ztDcMm/6
bPTdKx2tjQOxeuZORC3OXDIA3CtqiAJiMAm6Ni0fDTn1oaflW8d7dc9QvAQ93MzjsTS6E3rNSC7g
9bvtQXwqmuPHF03X0EQFWB8A+MuOiyQraOm3UxaP5oHJ4dEz73XWhqreolRZ251TQbNVPvH3wB5h
VdKDoIq9Jq11R0AhLYYb5m9hU9YWDGMeQUUPeoJ5ruC5oGTIm1xIksYJO1TGcfx4FIYAHKn9Gc0z
E+uff36krOCgcEyBxXjsXxP1Fw8gKskArCDXNI8TPv88amSlno9lGre2TiN3ouXrQO3+3qnAq399
61edlnkK1YzIBx5tGRmXY1nnoNVP47EmTZgIACGHoqge3aQZysDM9SDN0sPgZBGqNV1k5yUNy0Jz
fpt9u0WVsnajEN3CqUBUMKN1zvUuRN7ZeuLR2Bm8Ox1cNaxLonRr7MXqIXSxqvNLhIzbIiJIeSnS
qRNprMnmp5fLwzj5vwuF+l5Tb2TGVxWam2hBmI0pG8sRIRJvot17eRrrhd/tejWWT62txG2v+q1x
oGs2d07dzGldQM2WXRUjaTs1ZtjH1GmHp5oBE2SrZ7t2xogOuvFQUWVFZqXGrabs+c4uLS4aC43Z
WQNVz5IV3CcZ+FnyIQUKTDyXqR+xyg4aNgZjWUYNqp7M7Vjo1r4fJkYT9Uj4JaP5cVwyCCctF5MM
51kjyPCdH508lV45lYwj5C6BIUgD+k1txdxrB+dExrJptkwqNzE8yBjaA9pbA9spA2e8MfuPt2tC
GXgbMx7Rs41lCcDw2l4vhIGKeHF0rdDln65f+lVF/HkA0sxljFmoi8XKNfQ4OjmPGUj9avWGSkCg
N1+M5i9eSNB+YC42yFRRGVrYMWoUZOySkcdmOgUJKs3AihOAlT6uDcKEmVcEoTE47M61sU0qqF90
PK7G/WSEmXfTACO8RcO3tmanUhZuUz7ISphmz+O+GoPKriI2/MjTmQLh11+og2wFMMhoVwJ/2rk6
nWYJwanG4tyM3Cps/CCRP8Zm2Fi1NdOEnMUcySFHdZG4SAC4qBxVs7jV2zbwK/4ozeZ7a39whPx/
S9Mzcfk8j+liDCGt8xokThOLXa/5jqbPZ5lugZ3fk55LE4QarfGOiQMybvFu6KU9iDETPPaV/dkC
BSYodaNeoexdyBD2F9B0qw7cfrg3AcQpBv+Wy/wGnWfR9a1bW1OElA6S/2gSuEwA5JPBMdmKx9JQ
TVQTFU2tl2IW4F+UwFHGQMFohs7h2V5c4IIXWda2uMD9AGpCYWd0D/YvyoOk9ZKNgzKft4vFBe4U
OL35tVw+LMVU0cZpsLh6ffAfG/YXrhRgIP/3+YWN4Imb2O0Ao9rpTtBTL2i/Xt+UOba8+P1otJ57
8FB0WsIFqrx1OmFQHtNy+uWWtz5aWLm4NSd714Pw8rqw1RMAsk44bqgWXtTQdJ82g+4DbOh6T2gt
CbT6ibn2xo4siVr+c6fARqDjsQd/+LLg3vjShYGoRVxbBsfosenJTryDl+V7i3Z7Kyt2ZTAGbRnN
vCMTeZCp/pRIdLPn6dZ4+PldXa4uxr2+g+rgui0H3g2pU/bo1EUHDUPrDErBTZiaU7nXPeFFrtvx
UGCmUtAK/xU95VtGbG1vZ758TBgD+PIiJueYF06FrkTsseboj/o3JR3MDYT/vBuU+6dNGfmLDUaN
AuTKQJOiqL14bHKt74oE+f14JPdzYdvP3izjx/VDtPbUgF5ZB+xxnr64NGelM1HwM2FNTe9gFDs9
3Rv+wez+IpE3Jykx3B0JZQCUzt8Zl/okZcriMRAXB9XwAwgEHyeWbdjENb8UPEYgVAAFGMaKGOdi
skSH7+v7POb6N99Jw4T+1uouSN231uFBq48bl2PNXJ3KW2yQZXZ5CuogmCsWMvuPAUKz67uzJmBO
MoMPFiPOUOg7V0h2uP3KLuaH8yajd/bH6xUzlRwydHABL4fyce518O+9Ao5sHzikCkCIGP6FBv+K
WGaJkX6eCuoB4SvSht+Mg2KPRkq3CHhWE45wX9Bah5w4TOEi6df2zVhpFfAEdsbdb2OC0bvgIeGh
bXX9cSiS4tDxVL9RDUtQas6svWhHTO29ruuKfYLfgcYbEOkgbl6OTpHIyTsuBVgM6dxHgCJvUcsJ
Lbv9VIvpjzGQH6Rs9zLdKtOuvQNIYKOIiqQuDPRCd9qpljVOB+gfmULUtN+KaTgKNmxot3YWAS8E
1T7MEUpDi7PoTmmmT3xuvEuScERk3m/lB7YkzH8/ydiMtBYpyyEBfqjHgsbeX9+f9e+DNRFJaYBA
tcX37aT2UlcSFk/eA4vaYSMCWdl+TFVARIw83Qw3mPfp5OczU3Z5XcLL7ax7L28C8AOEHRCJeBBT
cu/nRmjrGxqtWe9TkQu7SuFyZ5jlgRWDP+bJIeTVjYF6mtkdry/dqtt7KmlxyCarAZKFNwgTM/co
quIoLGfX8nzfZvZt70gRMJfeevUY+KT5KoQTCY98bpN8IwWwuoeAbsN7x0t8MdDEpW5HZQ+cqzXU
rz7rbwGA39B1TQQ6OFCogbeL/y0OOmZGO7LkQEih4yz97CU8ufPcbvhyfUXX3ioQEMy+Inr40dB1
flo6CWzj6E1FPDhDlNJXK0ce9EHa943dBS55uS5t/trSdYKXiKwQTBPGwSx0otpE64EDMGI6ggdl
5x8582/Sgj3QwrzzWbcVKK9VSJFW+Ffi4rL5pIb1ywG5HvP6oSt5Ggqtuh27Cc0QvL0bFN2TzgnG
CmP3PNdSgdv00XWlVzfy5CcsLqTBx2nKJl7EdRUMZpTyjeaL9e/D/UZ6FjWuJYjN7kwv8XWF55O+
GOznRLaGB65ZdrTH/J+AhT9jN0VD8gq7lvExATpO3LQa+2laW2QSa2YEzY7AR2BkOYZfLkI8NqBO
kxIglihaCwN7al90PoZmwX5Ymb2xKas6ARJjY74DujmXr5UnUrdF92IRI4nz4I7W58zikWuKX9f3
fvXAn4iZr9+JMS4GbwTjOZbOBrFkSo2Qauj5o2RXFCLgW1mBLaXmp+FEmq4JMtgWlCodPUqbNChT
FWTOh/tj5sPwv0t3MYqqhYXlDFyPMenuPETh1ZPc4uq7rgjYI84VQQfQf0WA5cnoD/UvxHzXN2bV
7p0osTjTZcWrxp0tETPb+yHVv3HA0Stuo50teXJp/6k2ttgD1o834MEo8iMuX4INnZSVXu4PRVz5
2JhDAV5sJ6j/ApM5E0oBmQ4vDFHOwsSi4tETTwH26ZO34tmTX6+v26oSADcjW+fO/XKLnUlqu/Ul
mFnjrjSQQU26G6rZx6FFz08lNsK1LVmLPRpE43FnrGHYzNAYjlYf9PZObQ2qXb2iJxotFkylHloE
ODRyEz8PVDpETWXdd5N3U+DJ7cZpK1xbVQspbqAwACZBwfb8cHOvKUetQn9Z2t2yGSs+hpVLkFz9
m3fBtucDh8Q36nbncqgpG8cAfWzsDTc6qN7C6ydh9Y4CuD33S4Jsyp2fpRNj4xYOENwporbK/6GR
F7P82eVfrotYXSlwsaI+a2E+5hL5mZRl3bIMGjQ8nOybnAUdP6LT/7qU1ffTn4v2gBnP1eZzRSQ1
WUfn/Wg4/c2ltpPE/nldxKoimKuGsAzNssjenIsgSeZnhYsZsgWG3tkhnQIHRcatMH3Fpp0FfgtF
0FSWaAS+bqy36gbaGsHYNFWgevulHrwHV5AvYz5t1Z2N99rsv14dEn9gLcQoN3QZgl8OFZxZ+5OT
IMa6a8euEM/Ihxh3HgFrHmDUVuBk2rCXgz6Hg40I2qZ/9fz+Mc+CBNPYviFmwIQc5ybr5X2r/XCY
CjS3/V0ObR/4KYNpvC14tt9PbHocTPG9bvAfZrFvJEd0g/eRoRUsnAbCo7IG5wfsUBKyzMVUKN6L
wLXzH1bukMCdSLbracWDeQZzUHJ0uNRI+oSen5ohQ3YmY2/TmE6RyI1fdBx5mHhoyfMoiJ+auyyX
P5up0vZ8JCyYTJfuaPnJAEtU2KYWmlUq34z83vjqyfEncpPW0S/c9JGwlO1q2bGvdS74g1nr7TGv
mkPxnD/jwh4bn95P/J5aVeQVGkC5d11BX1A18A5uj3qeqHSGjtABAzcpfVMgvQqacvDAUg/zi7z+
rckOrnEzWmhVNvd5Cs4oRKuj9bMtRLnnKWh8tLofdoM5itAWIkiSHaU3vSAkIm5uBz3aLobeiSRY
lB3jZ+6H6LyB1TdFMA0mmK4GEOGpWupHoeONhF9s/ilJVT1RJPgjdGRbb6QiP7hpJaHoG2Nn9sIM
OZ3yg2/yX3ldJ0FNEwM9Kgg+R2uiBwMsGaGVdFUoupLsk0n+7NrBiyYq/Z3K8voWjFQsGhylgsqy
+6j0QLitCS17AJ1Iv+ulJUBVVKE3tavV54ZV+VPr1e5hGqwhKkiX3mdd5UV6U7xR1c/Np+yfjmk8
KHIm902XgAevy9u9qrDlDff8XSZdTDlCoqHYS8/GYHcnMQLaCiuio6duTTtxn7Um8fZ1Olp3wurp
N7O33d0wyiFKMmE2oUDLWQRXov2eqjzfI9XDAjeznDtXCSfQGPMCE0y3u5aO8javhXtT84Thh9TI
yisMBKgVpyEIDqz7JOegtByqIUgNrQyyssUagt00kARE8gRB5y7LlbCDqlLdH8xF5mFNc30HnjL+
o8GM4V3RJ3Kn1yDe9Nx9pu/3XY+qrV5MSaRg6J4qNJbhG9hajxAagAUwDYsJs370qWePSM/WUZ3w
dG/JzjyyZPLCxhrxzleFemMAmQa+Dk60VmvqA6K75q6tvXLn5J7NAHlCh27VpH0oZVXs28LCpCVn
YrsuHZoQ+ZQ08jLW3qSGUYeg5x2CoU3orqHSvBn8SoRg9dRBjsKR1qGmFRRdDiAI7V7FUJZh1gGZ
T/o0aHR/vAUVG6b6DM7XojH0w4Cpn2HmZn9ci9ZRA7qVsLdR/SLt+CSqkoD/gmaY3Metx9TFRbIE
7SNKexaqCQNzdeSlA3SMeodREi8CPls9MMnMm8rPxwiVGlwGfeA7o0v0HdqWARdMWHYrpMAxBQdw
UFE67UYOyGurcH0EWM9AgDfSwOHZj57Y6EktXAnuMxAhFsDt7T2tEkcjYd0Nb6dveP1EmAN/GWnd
lEZkqArsY0UjOOFyB4yve+wM5uxVbqQf8oL/Y7nn0dpAYMKjA2rj3HITURaqNyvxDJzhHffbyG5k
qJUYJUz4a+JQwJb1ZMOrey/VnD0XM+PzTD6GlwTV0feQ/eS5AGKZG/CAyme4lx7yoAN5S1ORIA1Q
G3dtqb4ztK4EYhQ4laoZ781+cHc8kf/MkwPCdnS/CUZrWDMPXezKN3a5KYbQbVoUDZj9CTY0C0VN
6W0vbBEq4EKPmHkaj3YtQlYi86osqYWWHGjsY3DkhnrnbhGWFBRXcCJQ3/NAjHLRdtUaVlNNTt0+
dyDqDklNvUepJTLE9HF3I9N37rlClINCNvLyGI1uzHXmxe6NxPVxvF3zuSry70qM+2bqbmmWRFnn
R0NjHj7ixPwPZV+2I7euLflFAkiRml415VCjy1PZL4LLAyVqpCiSor6+Iy/QuGfXaWyjDdgPhl3K
lChyrYhYEf99uffdJQIakOyUsuegk69c+tegbcqo3xFF4Ot/v9Q/S7LbpTCBDKLv5iJ6C/R9V1GE
jVpHLRVGDGg+HeVfPen+Hz8fsiEQDhBdQSn3X9IZ3FJ8Gys/rJ38gCPy65Tol3//Cv+1DmD0/x+X
eK+ciXYDP/vYoBiT9KuR2SXr/LfD/C3B4v0awFJDpwcvIehNopub0D/f4NQOys6rH57p/jgMT9bU
YBx9U4jlL4jn++9zK4zBJiC3ABHOeGvflfuyiRfmUtE9+2wsRvnmxZfkb/zcO/4EUyOY87oF9EGh
c+th31/E8lU0WBXiGbK4nECk4cmzzD50w/1E7BWmyUUayUI2X/79Wb1fDhiBRjMGXQGWAgj/95q1
dnLL3sdcPqvCNL8nBIv++8//n6b7P7c8XICjNIaRDYguqJ3f1f9dKr0/Wimfd+H3fLN2flhZT3GE
JUsRksZUo594ri26D7dgWsRCmfA9NNzkWzC/hsSxfLbRXIRKRhjrGe3FQ48IhWT3DOR9LJJsS04T
ZP8VtdFSpJgBgQbjoCjElQOy2aEsOuK1z5c+ZZXOouYptYgQtFwfdTw20XkOI/eX/emfSwbvFiIK
kJqGeUdMueFte9fokqDp02Pfs0c1nTpXkaHe+urf7+xtI/jfG3u7BObNbuNG2COwNN+jHZMZG+o3
mz2i+t1/rUfZ6Mr8Ldr9bxd5t/QPoF0c1oLZI/fFoMqOlqwror8Zc/7tKre7+R/H4uzEIPvRZY/w
0DrcYxMWYZj3f7Nt++dS/5/9Dugd+FqONhS76zv8RjJ+eG7b7uMMOU0tdqcepbfiL0fFP5/87XHc
1jvAVQgUb5NB7+6Yx0fYKYbonl1/GaJzNj+y+S/76z+/yP+9xE3pDFeoMHvvbzKAb2IuFuimPmQL
iqby3xfWf/94nMcg5yCwQrwZ5uj++TT0CHln5pR5dvORp5/A1/1lT/jbBW7L4T8eN/ITAyQa4QIY
eYC8bvlb1iZOm9uu8r8vx+0W4a3ABCB+weYBkPo/LyFhtUFEoJKnBDMuxTBNtIDlY3feQrmf532B
ThXF/WsoNdJXcQ6fnJaU5GGbNdhQXJJPVPQPaG/B7dpqlxbZSDbr6qVrf0aaxc/SwEBmhWNbU8cu
/EaI7AqzY1isVF3HL5jlb+4T9Ixo8V34SDq5F9oA0l9TmHMIHaV3Qslky43Rc3iJyOCqCTfl0UR8
fzYKagPv9kFAXiP+7GofT8e0SHeFuXVbrZFFqy1TTFHDXrHYHetLzHN/PvbVwl921GLKLYr6uIBY
yF37gw81w4A6yvgWs/fp8m3Zs+gEGHMsFuhFiz3ETtWRdix7sXbFvMetz0kUwJvbbc1X1o5DLjOv
TogzaR80dCR5zOz8lO6Bekl6MlfTpNPvcW+0L5Klae/j9FCfudrVQ8vH+IpQwbUyesrKfnJDDeEy
f+twWlwRuGrKGCqbU4Qkt1+62Vyxa0zRisWRagd0UfgU2R9QzpJLmqIzCQRz9Zr6nyOCYXONhOSk
nXnJe7NV2RDGxeBbdVo7A4ds0b6QcHkV7dQjxmuPa7lMsoBEcL8TWgTlhsigqAzZbutZgckEcrM8
EKTlVGDzVbGnVsORY47zbWyzh3ngx6NCZFu9RQjlM+OKj7l6dVZiWU6mSza0l3yBrG0159n2bUVR
NxTttAmTqwDGvNlGkgcFN46LGkL08+mQfkD0Bi6AvBkJeG/7QjeyFgpMUK0Z7MrCgMCTSaXbhY4y
g0re8Hu6OnK/xi66+f0c1w7KtFPUtF0NBcICVIikpZqyQNaBXlL+W5roAT2mz4+RIE6Q9PNLDGYe
S8bw3wk6V1616WrgYHC8TunQXPZ0dVcPMf39Ae1TMdjseJlZpu7MOLk/wqRvdqRrQWANX0PnPRas
XfYaNzp42jZ/fOhd1BepiNsznbK+AinOntJ4p3imCXsCzBFfZKJZ3c4x7HwShWZRKFZOEf5bNoov
2Q5Zm9exLeZtv4XLJOMf+LyF+RJBez2axFVts8d3O163y0HX4YpQTF6I0S+XaW7xgKHMzOONY55Q
cnuZsHxfdrOPXdFyzT6s1sYFMelR0AChYXFjmwI4xFINRwQ3vyS9pY/qJNceRhhUhD9WTqcKeEcH
RGDRZwM9Nf4+CNEqyvEExE38huh9zdkMJXqEONM86U0Du0b1I/VbWk0R+TDHx1Ri3nm7tMLMj8Fu
1aXnra1S4aMzIlyzC9pRf78eFO3uQtmFxpPAP44JvOS2ozzWGPFn3jiJXA4/lBNLxgIFo7vLVAJH
SGpkTcWKIbJ1yN28AMhYYLIp45GiQfTdVWkel6bx1yYA3PdjjD8DMHlE8JQomqab72OfivueLYCM
+DTXAk8wTyVy76ZPqYvKbIwrsSOo2ijXVZb1v1CwftxYvAXYMWf+PRT7Wibafnaxn/NpauiFt/NQ
tzqVT5gBbM7duMIHVnt9jfokqGInb2nUxp/HuVlOg1fbg/HLUQyOzaUbEFGSB6EAmLEN8EtbzE8/
Uih9my19BgjES4S/8XJhW1LCbpc9+GCXF4aIqJwzgxCwIcgqN4g5JxgVLNJpteUQR1mb792+VKmD
UKhYN2xedAvIj1ta4t2R7rpCMN5+WttNFYI1SSFbj1fTZu1ljtVYDSBM6nAUc03QVefp0s/P1KEV
Hzs2nKd4ih+sjY66VeoX8m0zyE6C4Mo6AnThlrU5Iz3paubm1UTZdz+Qb2465iLukOWKGZiujiyF
B9A+/QwtMcUR8qNwW4r9sR/6t5t30XmfRnj0K2d/H6Tt24IZHhYkNvaTXZS8w06ImELd9I/JQpcn
MaOFdL3sTj7rXqhJlmo5IE1qfPAxcpiBnQQMLGYTdRdgRaTQN9TUtDI7tYfZq2Cau9owLx+PFTbz
LsCtNCrIvnUeHj+zFJCUISLmzONdfKP7llTx3Lu8CY18dnGQVt2CIF/md4oQRWEevYNIdF9453MV
tgGaNZjOTcGSfHJLLIphbvRZh7eTr8EWV0QpZiOHYNxeqe+jMO/SwGGHx5EAgH//SRRQ1jQg84UY
1n+EmyVUS9HgOwCADbkeaifQMD9Dj9NLAKmJ+6nHhHzqD+A9q1QcYcPqRZH5qFnobU1bDl/F1v2e
ZgbGbZqy6yrHudjRsz9wYw22MJUVaZwA/Jbt7yWTWNXxkeZRM5Fz0MI3bAxGW+Ds7J73hL3NnRa/
Qtj8lUw3+ilN5Pwm9RHJvI1h/ReE+/KYSBZix46GE0I09cW3IQbZqZN3e0pw6wxKBzPLn2bnI6tW
TVlUgljvP2By2uPeOSlOvcUwUI7DW5VkM91pDKVAt2q5zSdNjhpuf9vjjOqgSiY2FHpLVa6yNTkN
epY1GdufwPF8zncVXmXAv7p1pg/zLN4IvkQ5Gg0g2QNInnK4dowYIJg0DkW4uX7kHMiy6gYc29My
w2ivibcPU2LafN0i8kg7SMhTItoK+g2fwjx8zHICcx6aJ+PGr0GbiFLvSfA8NxCIYs3rD/tg4GHe
qOURajR1StNely2Gt2ttiC4Ya8YqmW336tDqXcYswOpFKkqu4XlP/CbuSDynhQLaX3XNTGvM1nnk
c7SuVNasldXyj+TN+qON6G93++0w3oGFs11bvWWmWIM0e4iE+yFjsDEw1jf5kIbDeV/V8BsuXhSl
RIqXlZGfXLY/ZseCHxZQRW14aqqgJ+EnRGmmhYkmj/8q/fa49AEolsa6csiYOFsO+8lkS13RZS0p
XLdozLH4oNAKJvea2KEEo4wKQ1v/bAbyAx6P0kFDsb5Rdvzm0RRcFkMRwMmD3RdEJN3dPsDBEYbE
a+Fi+8aGBN+ZOGweWwsRZrgZnJKBdY/xIKKceZy3PrRw3wmWOT1lNn5ywj8yUDgb4dXKv6ziNRUg
CWhq8wBbZe4s35+4b+OyMcufYDx+r0EAsyoDp3FogeMCr7O7Q7Ex1yNsGwBhxCDhIBQrdU9sscSJ
ztN4tQXPNlVpJHKd0qUZcwu0vHRrMp5nPfUPM7afR9BZU77fQEQeDaRe1TIX04oHATaBoKKK6Hoy
q3Ani7ydEn2AKEfZ+NpkobhAGEiLqCffJ9oPZy9NXxgMrV1Zz8wpWMbsqraY4MAUuHUQUOWs82k9
7NFx4kfT5zvGpOpuiH/CgsMUjEwdjkET382Ni040Uu3nIIO15sJQt/dbby792gHVBw+Vx5gRvm8D
eGdnwwHbC3j9w7+QVwbw7ZeODqD5JtCJCicssHM5yfZqELEHksLH+Gj7fhUjVTCh4+mLTwHjhyzY
H4ZhF8XMt5+T1c29Mwd/6Ab+I6aouroRcQwp7HO7vFvFfO7SweSokGAWvXAM5MEvtkJkbnQWY7y9
+X1qHvcwVfetX1wRjgt9WRF2mFPs/zhr2wsGnz5g1fGS6Cx9kqntnweN8hVJJp+RKIilo9cwdzB+
v0wr+7qkG6+2cKdAOKY/xEdb2cz9a5thDwJCQtd81a2BPQf3TwMck4qEa4xJLJ2t4GTkL3TeW10M
rQq/aM5gdMUpOpgMVFahwaXetWEPqpgyo+ue2bV0dm2eYSAE51QRiQfsdf5s1RCcm0iuNVfgn1AP
zjVdOoMlPHQGG3+zPXRqFTlbl/jSexVmOeRCCLrlW6ZetGbRzxGme9W48Bb9yWI+jZ5wHJzKnsZk
ST/NWCpVSi0OJR4tBs8wjC6zJrwI0ChdN0wqnLTGm6go366Y9fqFCZS4UhPo1lmELYbu2raUloka
hUJUTXsU5A3s5wrOu6z0R4j6QoDnnxdWgYZYHmS3rWW/IhkyUqqrd+XfeqBoOUwj/VnM4ncEk/OH
TGO5b5iwurRd1D76PepztCdjnqyoGhm3Qd2O05HvfSiKcMEAFFitViC2Nzw+7l2nnprGgtg6fOZK
azg5G5WJn+zYt5qxbTmpowWDujTyPMAt4w2c3/EQk1lUYU8QuTtM/jllrf8ipy68qsP6kgeHzDPh
1UPQBGiQPVd3i7fZK1KE5ecApukddr7dlW0Q9KcQbdYJRHdSdRl7iVo/C1Cgu8uPJupfGF3OK4rx
BWghHH5JjoZrPqFia68Ychu/SKJQzOmpebVgv2psm9MpYtqVk25YAUdb4IsOPjDZYZBT0npYwZHj
IxqvGBSzx9Tq3MK3tEFld/YNaMmjo+7HpCeoapnQTweMH3NGvbx0FJ0xoeKnUNlH8KlBvqejzhsH
r+eByejBJkq+xFg/l7hR8BLROLZQkspHjm7+UR0Rrynbv3UaXOGEorJqTehPWbwu1XGg87e0bYvR
gdRBCz3mWzTEV9cZXXYx6lHiE/awbvRPLJfx4vDmnuLgSEvXUbhWYpeEswL/0FHhLm3aYox6cOtd
TPa+thpuUdjOwvsEBHyBnrd9nKd4hb3zwK50mqLKx2aCGzBEc4MepvO64Pkh/XTjGAS3B1hMc+QH
4Kw+P+bs29J2v4OZ6ByJStF5DDB+1gfZ921UFuHL/GsMocBZ+YnmpM/0Xci6Fm1m9gWNFRh1iwLK
bm1WhdpyPBZFy8bCj/loGK/CA/V5zC20LmEA3/7QYGNIGd7+DvcFbgi0nOHqCW0CJWXbxhADHJ+C
LkQ5FuFkEOvhHmRmAQDrKLvaMYo/887ZUyTgw9PBpLnganbnxsRLIXudnfYshAk0JKNVaoLo876N
YTl1B1T1jv4Cyd8XC4Yd7kc5vPkmWi+297ZgR7M/bUrsJ9K73yYx2aNfMPknMauKbXHeL2KcWN6u
2N+h55zuEJsBpW+4ukp4VEraJzj3GonOqeXp1ZqEvzrPknLvwuhbmJn04vtmfMGNE7jle/9T7UjL
iPvxO7dsxx4FX67Wx/fzEPY1CchWhVsU5QNjcNCeY1auMzrRdpl5YaZwLM2st9qkaNl4gJOITWYr
oABZC5FoldutB19izQDCGMNiIVyt830LQBsnhy72xtg8ttvvZkYYBJJG41ITrAyeirTSJjN3jTPi
nNFpK42I5XUWrq8xmFZyNeXBTPWFqCk84xUpOscv3PTRE+v78VOQwvB92ZYvfbY2FZ8WkS/NEUP7
gqk2FU74LnQADRLBRT0JkDSzSPrKW8FKNzauUokm+bH0gAmmxlcmI+a1X9egInLUoJiZOwGXD2uQ
ByA0kjncT0C+spzPU4u7isb44kiPjOImmE6M9hYCHTQSNsR2R4dbhdry/lagqoodGF+ijkSPnd6w
a88hrmwnVPwhzIGS2fxhOtIQUZu+XIdEV5oeJO+h3it7y/uXWaJ2SpSeTq3z6hI4r096dtN5NLM4
x8qmteXZWo0ZnKrwFaZK7Xx44K2j93uzbz+kpN+gDtiKdN9kBYkrJvzdSGqJcNZCtQk/STWgS2+E
PwOwQqPetWDtDzHeZ7pdPs1Czk8IGPgzIxw9h1baFLGFxGhzkJBkXE5nfM6sGPsQxQnQUkS2zOtj
uICui5JMP3er7u8cN2/QRCbY3wCWwPy3f0L/4iFmScVj548eRRCW10X1kHZOgcvO/YJcDLGBdnEb
xEttg9s9aCWRZTImr5kgIVQbzFfrLTLv0L6DFoQl50XizZTtkmDHTlRw34gGBhR7BAANO3POF/s5
pZjjmJS0pV638Cy0Hy8J7hKs6hlehFSuJyIV/bDAh6gOD01QUzbdycGvsUJsS1yLBgFMdksxNp4w
fBvFl5M8jDnHYrA17Om/KR5upwkQ2DNMFnZM/SlW7yGW7A6m/UlGnT3NzU5Pgt7OKvR0ddKtFOK5
NEOXG/Mctc6rXdf5HNoIRmToWYpx8u0Hwel8YUEaP0BPo8uGOXU59jCGPMQOdbrtUAq1kDo0S9df
mqEH+iDTvjQ+hCpHdPFZcJBo82iWCmsS2+I20nrxgBumdFl/uUa1H4NknUrkq4Y5nYBaN90NL0ab
6IpgZfXRAtpwpzZYSpxmXaE1zg8zstxpw88zG8L7HsRqMSUUzf8iGpRwYpruRmSX18LQ175VpBCy
SRFCspm8cwd8s/oAEu/WAK4OsymPofG4x4jWfk1aNp4aZEpWSzIv92G66Twb+HSatepzOIPMD8dA
XLklcV+ouKfPLaQNZydwsB/B9PsQ/XjBTouhrQnY3DEaf4WbMeDbrUEhIbbhhAfZnK249YiRzsrl
iIJXqBrTckwC9Ews3q/O6fna6SD8pFpszkcg+pqnLandqN+AkxMgL0eAnGmHtmBcIBNEImFUp4DB
ChP09GR4L4vNJRDehMMCDHj9gnpXlh59VOV32eQBOP2LQEjEi0P4r6YQ7PpgcXmPEiqnHDpXSK58
gfbxFg2Btn1AN/x1PML9fmHBpzgBEqiThhSLcAQHBPREgiQY1Eg1AKlD/eQDMAMb6KRyRNF8ksf6
fIPzi0ynOKfDxP927TYCdiLgj9mM0rEzvTj3oxlKxVXwtUGXcB+ugCG7fkDNgKY+h+kUr6EHNy+y
fybTXS958JaOsJQPuM6qtetxb+kSPwKzbAFd4eFyFviHlvY9hkdSedKZSS77mJhPUdtADdgRTJZ0
8BDVTGx1s0+26FeFlHYy3HiGzecs7ZYyY6EqrE6wOmLT3bkZKmA7MpFLHq+vXQ/F2TrQ9aNRU4q5
UZ3uxTL0BtM5MEJF7CYrgmAOv4BxsTfPWoDk06wEmIQpAjI6dhWi/a4IMs77bRie90B/xZQLAH93
qAJxtBZP2K33SQbAZErd+qtfMvvUUKmewtt4YDJCeg/noi/yaLY7iOdWeHNNMAAB8DwDkO9kUmJi
k1VTiFqHGzF/5nwK//CGpBtWChyO9iaAFisF3LZFM3mc9uyHp0d8UtJRAFID6kKy6jLaPcxv3HGU
ITa8kwylrR0aesyt9STXge9rNHb82kxAx9p4YBCHRgx2K7YdIYk7BrHncQbJw2om8c30cwAKCXXW
tsNRmjTrkePNaZ4Z+sR6kgP/xrIROrA1AVAG9ECUorVzkfI9utu62D1CK6Vr2HQeXzXW7tNGMDeE
zjBNoUVavio7QZtF1+UTB3HHqfnZIA0H3AROGzg8Dz9SScILbVr3FKPkylnT23PTIkoEVo30e5qN
5A+aw29R37hHcG3ke7Yf8ouMZxPkFmDZVzuk4qKAv50CRz5x2olcMTQIS5LWNNPsEYvuC9Nz6krq
zPiJmGXJebsMJ20OTDbNyzGeBoXRsnLGfGlaHcviUd1gnYxyBnq9JtET2spf2AzNU8M6Wkz79gKq
sD0POAUA6KJksCEkCXYGJBazjWHEXMZlhiBMLKd+xV7L5QdM3b0R1w13aCXB36jGPq2kQ/+JoJC8
1UANm5Y3mOd1bxBNxVUbje3JMGoXRDLQ4N6DXiihh99LjQXyLB0QA6sjhHeEaPcxVYgKSq7sfiTe
/qA39cwQ8PBbIuKfSdwQcAzIhX7q1jioFtaGV8oS4BlDQIsxAEytgYWuxdhiy6c+I3+O0dFiQArI
dTUmK62n2cMat+0TlEJY0agobEl1tn3bIJIIk64avgd0P7CzRsFdlo4REKAd8QudbFqcTJ152+jA
L8CV3fNAUqzI1LHsit1oKHrk4XyF6nuB7YLZ7hzOxkLJYy5lm8KewIP41fRmoArfjhS0VoVODEFy
PpDyNmIFnfgSsrvFLvqEsZGtWBiBNPZo0nMwDcleYujQfzY0ldCrKuCxa9IuF4i0oRNON3qaO5Rn
s2Fbecxr+humNFuNOPPb0YxeK7z9MXVzcMq6GV+VgRlb+uV7wzZ6pqH8tbP+uIIDfN2z4wsMo34l
AcG7Z9oUCfWbCAjqwTZcP6Um+zjPO9lOWKXDKQgILdy+6b0ggAa+qIDyX1KFvis3Eab3Td8yVA2A
quYuRpI3ArDv9TCzD344RjBYKrmmGMZz5qFLw+VEFjg54DMdudolBM/hqPoiSFIETfUQJuujceiF
sF6gc5GCbfnR7/604emc4kbYb61k8t6rRT32GiTMRKHY7MZ4KBlYwEcgGsdS9bEVU5WCZyxB0OKg
bVb6dY6DpAC+zHFiCQWN96TqDiRxbekEprAlRxknq0AnooMrYOLpCmRmujQgbC+Rh5wntduQz44G
OVAVrEbQHx/40drzojwaGD72L2jEoG9V3NZ7FrtzBDP8kjdhVklYbtcjUrPrGQnOIN/x+pvhgLUF
ScG++fk4j5Y1ZepCFPuCD4UVaV8kPWO56Zu4tA4oEkHSTwdzsZOY06EyvAXExhRs+hCd9qcLsmPJ
EfcTAswOCRj5W4nGJjHkeBI/uFrJL+DZZMPP8utHu05pZYzYEY4+bHXbbw7NwkjynbTrw9YMoJe8
C8sgdVOd6CS6g8vhXvB4C1HyARDfdfcL/XUIKywJceutLtMZrIk7AbiCgY4pyAKCiWz+R0pbtNbj
saPQwJ7epbC2gjh4QzKSo6GG9JnEAHjERxx1/Etzk+sDau2/7l1Cf2Zq3ICQKOgRetahM5M96EoA
TdjMf2Iqvn9mIJSqcR8QY5TR4cWbLHrtt3H/gkHRTZV2HwZAN0NYaquXfFwsQo82oMUYd3mN9Mzy
ZELHnMWiLVVow7tjCvp86AKAVGkCqhE9EOZmtwSFuVw6UhBwNz8CP6u2lnOQhOWG0IFy7/fvrsF7
nR9y3i6Zju2I6rRnGErd+0cvKAYVQgqUkMZrHaZuOwfNseHixp5H4cQVzlC8iKckfPUDjUguW47a
JEvck1FLVLLYt3exYOR7MHAUSJFu5jqa9rDAWmPlzkJzSdCufErQLRWtGNM7DyMkmad0/pqtt2iW
yPvSxzA3WRvSlOgZNEI8nbyOZAlBKcb7+QARW2zIZqs3qI2qwM3bCZ9mP8GZLa1j0pCveHGAgpOG
X6Xny8chpfyTGOEh1UiD0XQB9rFz21uza4N5j2ks+oUsJZTI9q5d9FRLuo2QznftNTg4noUMUSMl
4KTnvDMrkNYEw1ufAj/IXyAA07e24RIn/m7/LEs312jX3Wncaf9Rwg3/TInq3mD1B7B+RfsCgM2h
Zxy36miW/lMyevMCLhFkqQ2gEYbLDMWMGzLOn+BqP+aOWNfl7Og8ouh6kLBEmzA3SFJF3+7QBdgV
T80kI4pCn56iaEEulmGkSoF1mIoGzN8BCjxK2ybg5gz3dcSGRyYn+7QHS4Rthv0ak4mgMARE7di0
3bFjlJcD6C3Ypvkmq8FoEjFIWNyXhAAGjN58H5AqQfgibDNG8rtFmZ87j/Q6Fs5JjbmE/CBT3lpX
2C6KczuGLZrTHWMyCIQLy1k08mOLhfPSD07+AhJnTB0tR/cM7hBKfLwqJ8hOjxxtnSgHLO+2gPWJ
R7bT2j4O4O6AtB/kMgxAwuk8ZGfcbf1hUhYjm6kJnzvCwEMu8ZNFkfMhQp+moK1BPldj8JoeISQg
qHlJhZgQdZn7Ya0oZj6D6E50mOLpncdLAv9CX8aM6OoYthFgaEIVBkNAS9x3E+Ryo8JQNTPN/Isn
gMp3eMPfxXMYf2uR7YBpgkGj3LjVaihOamD94OXgJlSBB86uG904esv0B6xp4P7IDYKylhVbyZIt
AAEFBsahCe0EXnM+s/AJ9EP4bUSXFZXrgVpd78BLQGVAFDBEHV+LOHX+y7Js+gxVJDCGmHTNaWwZ
YPmVBo+wlITEKmnXKth0BKIKkyzzHOFeNMxvp2jdhj+W8ua10eHxQcou/pL1DbApKVB5BctWxUPy
gkgMrgsUmvovsrT/hwQXWn9KoNGnHOTEe68XRbggWyTUc5eEGBkDTb93VWTGuwg+ivDR/byJ5juB
vmBe7F/EnP8tiYNnGoWxEsWOBcXaO20ijD3AqUe2eaLYHwxQ2f+vgcibHi6DEo7c7EVvLqnvo/CG
fSKwbAibJ7IPD3CnLLfgb1LR8L3m7qYghiT/NsR+m2J/n5vTG+8jEa/qMaSCAucJ4huqt7m7Yd0w
+xKPGvM2/KiEBppspsA+NIT05TKhfw2kHn4bmx5oIW1LrlaYqAJCO11gsh4COkZnvQEdBNBpwBDh
zAY4n8woMP6yCN5LUWHwipQh2FtgAANTGu+Fu7qneiFEHc8A+kRp/g9p57UcqZJu4SciAm9uKcrL
Vct19w2hltR4SLx5+vPRY7aEFKroOTFXM3uPsoAkyfz/tb41jck2iap8I1OjPkhqei7/aXYO/CNU
tBWES8SVYiDEyWCgAF86C/rAsDlyApELHxH9TP13p2YjeKPW3/FY0Xo/J8hezPIPIy7V+fRv4rBX
Z3yeWvmrGupF5ZhuOYYvSV9T/hXsI6geHqSiPmaiPX0tLiXU6t0VYzmZ0cO4bgDlzMhea3HFshQE
BiXm5iow6wpXlUXJNlHY2iHumPpfwPZCN9V1seK4StsqDuc5gdLNZQ9E4W/iHKE7Wf2DGglKQroD
8ye9f/BxmaxagcGqVecCdpqxuFPC2UhKkM4xjAaNlRgCEjoWc6NE6nQxRlO3Mhq2knRlW2/KFFpc
Tr1POad7uSo5K3reD53a5h7WTxCrjiKh+6isXSGN1E0zCjFSQLchr/J7f7AMtoyyQuhiqOorXUHs
xJ6UNRlD4NbPJwR6IvfXaRs2Rytqik1kZclVw5JwO7ZtdWX1vJf5VN4lg99cR4pcH3MNZZe9V4SP
jmogURCftrQTYpC8oRfPbHAct1XL+sHqJYRuwdB4FaIRL5YTe6/a1YH9OkeIMCr6g6Snr7ydNt5r
G+UAIbmXlp2Ve0tx+u/44qhzt51pbcZREbx/HExHnaOD28VY2nD8/Ma9lK5MU5a8XtXSTZ1TyyqN
ukZPjdl1aLr4KkVjchIiSIzNkCXTHrYIfk4MZWttMLOD44wBlOFKie5wRRprvZWGFRvSZ9Uszf00
y6tG3NAHlO2EQg65hbXTHzQ34d+5DNORJZ8DFfuSaDC4tyk6yshPHtixdF5vKd1aKwSyyKz2X20T
c2NfXSulvrajzNWC8IhGht4PpmpvkPviZqTG+aqaORXxge4eIFlzLkPnMkZEtuN7RELjRaCq5SbN
09wVsEzJxnX0FXsIjsw2Z4ajY7YvEfXdkxNbYl9bEycNRYqvlKlI95OmWgQEO9mW2gEbpDGpsTxi
VF71ag3xsy7GtVyXNOLtckSV0xm+vhltir8ugXTtsaFy6imNj5uwNAcTrp490skwp+dO4n/LmX+J
G/YJLRnyh/RNOxVs0EMR4Z8MIkI+9ah9DmQfxZRSB1dlIw/EDlbRZWkZ9BmkTvamvtEOfViIwjVi
TQb6JBcnIf0Y60f4rao6bdGoYjOswvDe1sSNVBUXESeuLvOzy2hq0RuGqYc8sHjIw1r7WZHUeBuU
dbmdnCDcCyXrD63ShldOL+wLti2UEYkv5DEY4az+LizzGI2NWOu02x8LhI73WGnHbKp3o+mUBJJl
RGhEWEfoRlnDSbboHJKK/KMah2e/1sQvqbL9VazMfUuKovaVhGwFbaqh0WAMFI9ktW6FOyTdU5Xu
D7IVjvTIWooMdd4Si4rNbFuVra+4au3F6jqtPBNU/qPdIViVoTCk7jAptJIrJ6KV7hB7706Or21o
IKmXYTcGh8CUXgRA1C0O19cACZNXp0hn+An+b6Q6YjNIQYdyrmpX6oj5erTK32PHadcMLUrpwSx0
TWVrlwpBYcZQ+4PKt5NHGpnI7xT1zlY5+/fm8GSycXxRqkA9BIkV4QfO9UspdKqjZI75etL08sIH
VbwWde9cFHVKPWG+h72BP3NUpYQ2A3bRTBdUppspDs7wr5fEoX9/zHD7YKdkbi+dA6MWNbQagW/G
ZXXwh/J7O6GgoaDdRVHkdZ1vssQgDh2FecAfdgfFevf150X57HuK6h73jWaRm7OEKUdJpSkNx8eT
KmkEHTaXXRpTjFWn33YxfTcF3S8nfBqG6rIYDM/ABAd2z6LsHD/Fkrmr4rkdrKyGzF4panWk9X5m
p/fpD4QZoc0YKNCxC2dQC28Beq2dntJMO5nTQH3TcdxGp3WRoxIkrdarzOY5tpIz6NVPP/wcjRVi
GlS42fbS1yFqJdFj2KsJ+kjSc9wqxznEFjcz7oXxXet+2vWFdA7FobzfFv5rv/F22IXbY+RUFVaC
SeETaJxLu7L7NfQ/x+BkQA+Phu++jyq9vqYkjrb7XJTCAtDwcfTF7ZaLqEBDmmUnKaGCgeT8mFql
wbEKqaKZ/epMhPBNkPOShCiTqAY+U1J5TTvzlrz6FRasTTlZFwKVpCGMPezDyB0UgRqpfO7DSqIs
KN8Y0oj2us3XomeMaspu7FKD8UUaAaCF1Zy/txm79neRoUQ08mA1azZ6dhxKjvZOMtdxjquDLtlV
OOhrfZq+oyg72gmlfbvHY06nMCvCzdjknqYxYYKQ5QAqTOsLNkRaep/6wZ2Zyzd+Ila4PwYXZR9t
gtFTBNGlpbLWx/K2N52NU1DCHXJ7ouBrwo3tQuzlnIp1pPkr38j4Rikxdnl1W5nqa1fqT4gpkZP3
zbrKSKgci2NEA5gyM/KGILgro7pdxbX6yPflaNmvCaU19iQPpj53zdtuKyZe954O5yroFRob3cVY
6HeD1F/kcbku6GuuyNNgwQq+fb0QzM/1n331vMvET2lgE8ZQCw5SX5hDTbXTowZRyFVsIETRepN2
k9Ol27hRxdHIm5+lHZ+jJy52tlSYLU3BTs5/ZnvZH1PSG18T5hVfC+XUv6VdTaWVguNoUZI9s4As
joqONp8PyUKlo8gKQm2AK38zilQgG5JSS71N6++p/3gunvTDn1dwoXK/uBSsodBn3v954sp1AAWG
9K3rSQU7oeM/c8Kal5k3T4YTtqXyiZ/jYkwTadzijSyjPu10XzG+bcbkQQ41pBj53xl2aR5CscUd
CSKe7Hd1SbwPqbBrcFeqk9WNqB3WHR4ndodfz7Dl02YB50jN3TL52IHlWljQhzlmTlZ7cZKNft1E
67KTEXA/ZMiYvx5osYJSk1BntcocByNj+jOcxSPJRa7WyZTwuUhrjfdVOVQG1jGjQe9XtNn1LOGi
XHusaxxU04AhtH/AW/J3JQR+BdZ+lI06nmvm3rI6okhliGbE6L6p8vTEYvgd8MrXFzrfsXcz48+U
49W1FT5TWGjfT72hH9BT6ja1UlF6UpMcqfB7WBxWIED2dVKsA4l+wNdjLqc7eaSABEhGNhBiMW0W
H0WlLow2BwpyYgdcWmv2kv+/v7/4+umqKGpaYcUpTU8OPUGx/frvL+8Z0xuYKtOC6sFcuFoUjiLH
r/2YstKNMfnHJgy2ht4e0s6ahR25W6U+uvO/gy0RYsKYc/Ct6mBzhSCwuKap6v0qMBvlRg1Da1ij
0p+uZT+PbgNdWL8a26zvKxurS47ZMTrzvP4Qlf6ZJP/+oEOQZaXFV60u90/s7zhacRg6UWa4oSgf
uY0zCJrB0mEI1G04lmsjQxRuTlstno7K4N+HUb9SaPJQvnzKW+mELvhMVWPxis6/itVYVch0ZlXD
674oamgFJf5IL8QpKV8Mqjd8f3U6gZJyX8Ybh8aUND413Z3WshGvzkwB5f0c+NfgM1GXDB2NAKTl
LZGRI3TmmLASdVJ+nGimbzRJrdZRo08ofQb5d0VT+dfkNMhnrUpcN+n0i1ZVeJjAdq0l0vcObe80
11U5ovaPguagUzrZyH3Svnw9XbUZZPn+8dHsJjYZBArueNQE799xG0UrEhejAJ22j7qXqHiEwHrp
gJ8rnBudnl/cXgbyT8Q/blFeaZb8q4LYZEz5RTVcw38H5tR5mv2UJ0gk8t8DdetUAi6qYDlLqdZi
ww20i0EmeE5Obpz4L33983Omxk9MC88ai/FiuYjiQFADHcUJHO/RH5ObJCojHJ9k1X99oz7ZrbPY
KqyC1IUxMi9TumBUKZWK5uKUp6jcqDWFL/RA010jWS9DPmTXkaMPlxidxyOaPuSZ0aBvvv4Nn8yr
P1jyeYFxQAwsnpVpRVnvt7U4ReXDCEktzyZ6mqWLTs9Jn3U53X093sejEZfMZ5Wqq6HxrVm8RJIc
FLKRcHOD3DGf9X5K6WBCUQqsJtwRy67eZ0mVI1pSUIo2NIu+Hv7Ty4UbCbgGWBuU7fdTU5Jb9Bdl
Lk40SrHAUYx2gyL/FjUZLpVR3utB7rXOX0Ir55XDBsJKqP38RgAPfz9qLYc+ZZ75JocA2eoURNnw
9ye/d2P8eSnfbBkjyxfS1DXiRB62Q3OqGfWVMB7QgWFDIIbbWedKtB/b/MwEmu/Y4mWfgw2po+sa
RJhlPUBoCnY13+aOKs5dZyv07bv7CTXD1w9O+TgOewZCefmGA//8QNsoI+Rpam5Vp1oxrms/v5eK
DrFZugtCqpN0tMGT3OFN3jc6+fP9RNW7Wg8a1iYnE9/6RDkzk+Yt7Pvrfv975pn25n7jbQJ8bNsV
J+1ro2Z1YuagV3Olutr0yd3XVz9/bT8OZlGB5dOD0n8xbQcIDhPOAkT9UbSXCwSCbbOf7IxQ7b+M
W2SuQlaFYE3/iFbFBwB9NLL+jegCED/Ft6ZROKdEEc4miNXfgT9aZ+7iJ0+V0Qg4I1JbmwGF7+8i
nMNWibtmHo1DtKg3skWos3pm0fn41rOf5cQGDWkOEPzQeXMwWjThUJ+EUa3rrH2ycF4C+mcVSNYx
GXFofM+8FvrHJ8aQgITml55G0+KVl8bKSgeFIZOpV/c4O6SjXEr949fz4tNRHF2lGCbLAM4X80Jz
wENitKpPmshPeaffalp45t59UvAjj0VXNTqLGoFfH85yWqSjo5/qk539rtRiVfYjkqyXwaa0J7Cg
DZ6en0gBhR4Rnpkdn13e26EX75iG1jmw7fm51WJXKg36jQ759df38JMpyKle5ev3Jztw+RHOBUJ0
dILGjdV1JbAKzbzE4pcdpwgw59dDfXyN2blBYSJWh4P3h8clxZ1Tk9IWnVrDmph4aONCDcLESHXe
E2UynVk0F2sUdQPd4akRliCr6sdlIwmoZLRFN546wntWUp6J7dTKYBTTUazJa20pFtXamQrxh0HR
aYEsojCDsXIG5bx/pf1UTRGNt9bJ9ut24ysOhaxwTI6d0Vubgft7SHopOTdL57/6ZoWkUiLTX51r
DmAU6DEs34SSdmc6yNJJRTW3lysl2TQNHtq2UIAw1IFyLVlR/0ihEMYEW+WDHdRJtqpIUP4+WQl2
FjWc4pXT9kRvCBzGWVqrN1MQsVMZUFQWdEj+ajLwi2egPaBAmwYpi8Ri6RNyqrZBU0i8O0/J6LWY
OKub5Fyu6WLKfRhlcd7WS2NKnCGXTr1j38pCFLdmiOS9DwjLkOXiLzPtVYQVPHRSlNg/Oyzoi8JV
IkvaLOUtT+1IRw9S25mXdbEifPj78z9/89Ul3Q7zrOyUp/Jng4Es/LtV+8OfX8wiMUyFlUn8fH1c
WylSzjML2h+k87tpurg/8+N68/tVQ7JkTGLlyZlu7AdHOVEt5fycUQXW6ERvsZnUeJgeJ+nb17Pt
3I2b39o3AzeYFAvR6uUJx6YyeKI9c2Xn/v5iqRYi60NM2jwYFjZk5+ckDef+/mJVAVM+SfLEk8mn
K13/Jv9djchePnljEc5gOW1jFajzT2wzMXNcCenM6774zPx7AMh/nCgJgVhuCGAtD5jrpPJk27dl
sR30rVI/f/2MP6y8fybXf4f4c9x884zlpOtSqwgqonGGdTyL91p7pduPkjo36M+VLM9c0LIqZeOA
hQTEq0j/z8HPU+8htXx9QeeGWCxeOJUcbZzfdhAtub5SlYt2OjPE5/Pqn3u2WLCUuAogGDEE8m8s
I87fcdD+M6/++fvz+G+eia8ERp7gQT/1ya7K1u3t/+8OLRYsRcIzm0w8cs7RUetl9KCb/2nJ/ecK
FktWn2SpGaV2earu1IHV6cwD+PCBmietDU/WmbVr2MHe3yDBYR0wU12dhqzeYo0EI7nqiu+1P56+
vlWfPuk3Ay1WQLuGMKOaVXVyrGvJBAMenNmDfDpbARZx0KD09QHnj7R1jJU6rk5ylnhWR9O5vM7+
MjrkX8vIm0EW8wmp7WACjapOJgmhGOFuk87ycGOfaQR8upQ4Oom1tLk001hsTpDgdvqIZPVECGW4
6s3VjYZYxjiTjPfps5+xXhwu6Egti5pGV0t2bjK1dOUQ+0ft9wS67vvfP3aaOOx+HZVt4TIJJ1PL
hpZdV50k6xIjLg6z/+H9eDvA4suHeWgmIjOAgyyt/AmG4swAn90lTsbAGqk+cwmLiZsZVcAdnMQp
e4ISXwxbcCCiOLNr/2zy6jMiW1UcmbLcYhA/bXz4FJSPzPZCSr8P1VWjnClRzTdiuffR594S2Uc2
4oTFWmU72L66jBI2bIw71SkvJNm+QrIHkDA4pBGB0vpcU//7x/920MXyEoq2I4+Ior1hPbuq8+vr
v/7po3lzSYu7NgYZ+dEQ+U6j7ZnBHlANuummPdPq/HQUnW0DLeG5H7z4RuWBHbMzDcrTuA6jazt8
1jmzqGe+JJ8tjzqkbX0mRs8nqffrMGfJphVCYQIkB7HRzDMP/9P59ebPq+///GRDnAFlwMMPWmwO
Jz5Wrbz5+ml8OsFMkwwSqq2cfBZ7xClDwqHqAyc220DRVW1thagOe3ANMCTJztD+p1v23/GWe8Za
VGY6JoyXsi3JptuxVFZfX9GyQ/BnuecMb2kcpOc1cvHOWA324Qbl/wlBKrAWMDAGYQ2AgBByAhT4
pZzjqn76nN4MuHhforCguV0xYKOiCr0GXZUVu68v6tPp7EC/d2jJUjlezDTDqFBc5QwhYcoeVIz0
L6Vhudb+62E+nQ1vhlnMOF57Y7Lg6p/8PMSsuQ2qbaluRy32wIO5AQN/Pd5nn0xKO/KctaTO8dfv
Z3iZmYWRp6E41flN4r9k/jqxLmBwpef0b5+9qW8GWlb6LbPrCXtlIPs3SEdNP1Ok+mwGGDJlCYVS
F1WV+b6+2bHKRpZBkWDFtLWNbcKwcAPtzAz4/Ar+GWJxq4Y4cqrAyHhRIVGa4bY7t5h9NsX+uQYa
nO+vQYdcY3cmbZ7AFK6a4W2J6Mvrldtm+pnH/untwgrBVwBpA+Wn90PRZUBrXSrFqZgwwD5z9s2G
cw3xTy/nnzGsxRvT1QlIP6xrJ/zeuv4IugvFs69pZy7FBADNr11+o9m+/udqlu05Sx7M0c+04iQr
WYFxz7Gv0jhrvaFEKVTjR9/3VNquEqhKx7jDwQQOFVOxhVbbKKvYE7BZEVry/wCzbO+rUsGwltWz
vyyV0mina00A4UOXXFAnOoDHIGcWK7m5K3rrB7ww+ONiek0kyTrFOE28eCxLw2tDC9lLpBkNjDrV
2eVZCrq6ChLkIpm/KTQKKJRPZ3tnqLCoKJYbGJyEKtgC8CruU3S5I/hnD1yL2GJ7e7abKgQ6ohSr
oIx+oql+6XGoruOhbNZZVINKrQErRlNvvuJe4DrVBG4V8p1tlgBAJpdWBfcYh6dpGA/5lHH+beSV
Dd5KwsgKeQpODgKNINBBn/XA49K4CM0dNKsI2GmFtFsdByhekd64kQq1R01Mh/iZMvcsA6gXxWoH
iCBsw0Qd/J1pxOJGLYilzAJ9jZvU+mGBM9lqoEm3eRm215iWMZapyOkRXgFakAn6rO1MJb6mNQ5Z
JbpVGJnxWjIb8rK0rj7KAvwHrKD6Ar6i2CekFrlqVOo7RfGLH1YT1Fujb8u1pXLocwpcmHaoWYdc
wVs+peSwV2BMPIsEOM+vup+1Hpir3GiV374Os0ytjP5+LE0VjM44tGBXAY+OekXLYJotipXw8WLb
WrKOujbypjJQ3EEf+9LFMICttwSH6Th5c0/Mm+4lWe5DXYbqepH2oXqhBtnvUqEKhFLE3ndtV7iY
98xNNREJ3OagkLBAq5DHef/7yB5+Rp0DcBKMzppQFnM95pG2EzokCXyM1WWU2PYh66tmZzgjdkIU
fjxLUzmGQfmLiWFtUnXUfgSTiaNarfEZtoG1L/FiuUEzpuu4Gl/U/tiTgNPl411p+bBHQ5SgIgy7
K98X/taI/ZhMrulPmuALjkQJ/orN87Dz0jPBfKVemILjFVhRtiS5xWu7zpt9bSKc7wWmseiiSw5R
6ZIjhB+5zSwXloq6xZUX7PK613d+0UKBhYmGYTPVcPD3ekK8aPu76qWf5UhYDGAEf+tblXpV6xlS
1lqErIyj9R364EhYY5pBlYlI00qGatrWaWW5slaTtQnV1euiULrJ+8I+ondqNo0RD26uYodt22g4
9iAR8b5AU27CMrisLf1VcmTck3ZjrJQSh3+Xgu7RE+vnoMQIr2n0rTj79ZtU8mXXb5Q5xS8b6BVo
0WWVhN2+9hX/mx9M0b4WBSFRQ1lcOyMgFmcCow7zAnJ3TgSRpAJnwkwEBxDYxTpLIwU6i2ZfRU2I
SwKDNmdY49kEsQ7lAWNDUtq/gGzDYMaLvrITFTt05tNcLUR1BFZExV8OLnsIafvctxERwxFB/xHe
2HJHinBh5w+gFi1X479uNL01PEJ//U0XTxb8gWJCcwuwv4597PhSr27ETGoxRC68kmRZN4LOAR59
Bl4MOM2zdAYeZ6hycEgFFyb/dRXVkDTDtogA9FbiOZDguICLhcOtWxLKjLYcV41hvYbUAtygJq4K
q164hkKerrTGznFBJQNuUhMeuW2TrUWcM4mpsomNu6mPph/p7B9BdvZB2d4GqIM2zcxtacVUHEKb
rXOXwwozi6l063JCrp6Uvsu/4d8oU9TDzhI/4jbSVglHIK+tI52fXNH81kCwgjprQA/jcgzDENqL
QzYboVPOuojwZUxwaTeZlAB/quTgua1SbVVixV9FpfWzgiCy0qPkpc/rV4FXHMF8/NIZ0qMmWkDd
g/ackxQNrJgL7VBIujyfZ8NAsGKpvlgpbQvbX4tjb2pxI2SNCG9pqSeubwElzBvprkoGfmZppvhJ
QqwjmTxhNVIV3uOM9yarIIHYubY1QY+5fcnWodP1ACMBlMy8G1G8AcGq7/kXeRPTaIAME1U0RVkx
7iOrxopulOmDlWX3Jg6cx7aVsmOfyOVhnIrgGNAQKmGqACNtZ4+SNVO6oBtIz3pgO16WA8GAWNED
UA3w7DgS7ni0Dp4SOuYhD6xX3SYEZAIBc1FbDrzavpZcOoAywu56gFBEfzuoOgSkpoi3aq/r6y6m
KCjznmzgbJnf4lbptxwy60uQuc2VEHp8qDLW3rmbd0GbMPGSIewBoxi/WYSE15mBxXJHDGFnNpjT
EjveiM4Zt5ABh01IOYyp3bcoZ4AOwCAACKJr44qP7XRQu7b3prpWb0Ucmh0HirYl9Aa++TbCVIfl
3IkfdEJXG1dl8/wsCZh4LmRY0qr1ipsp98EpHub8BrUD/ODg3HAK+8mJ88YFoA44zpn0KwANCVTM
1DJdFSQHDHk9uaBH9d2qjR9G2z6MBlDBSkujb0DQE5y37AKNDga2aY6Oi9a6OqatFNwYEcQqB0TM
qqk19AhDgg2194eZ6FhlONsjRdd2fhrzEMbAqA650DEU2IYBTyAIrlWeGgJ6J9xYSU44IZvcTZPi
ZM9n+GOe8vLTZPbdFKvEyrJasHlhnrppk0+HwdKHjVpp8b4G83DVJTr+mUAnusDXX7MSC0cN3+Ig
N02z7pXU/u4DK12NYgx3gr3HysoAmNnwuuB8mOr3GgQv4ExcsFi4J+NuIgUdyJIeY8cOlO5bBt6S
OS/nl4qOwbaX0t8ClLYbxrSjatmsAPNL0fVUYJfLjC7ZIfefrgVSZP6xVgcXutnj8IIkchxnzRj4
0sDji+ff1k2qbwOj1reNnA3rFLwR5vZWPOQlap02K20M7ZqykbDobpscGMeqkJqKFI/OuQZkxDwe
S+fZrixS/CpJ8SD7OjcELthrXe5xrw8Nb2vK5ol0jxBeinhQc6l5MgFZYPVPxgxS95RRAZAnFns1
aeFf6b18UsrSv/PbAFJdWw7bJFd8L3DycQ0XpVw5+cSq7NvE/xlS1m6nZgzuZCh43/SQTyD+NShX
9tB5Iuj8NW10cafPoA8Ch+x1I7H4gPTE5TJo8QZ3mb2NbDn24rKDGOOg64tb+9bMa3ilPvvHsLf7
guzO8lXDjw62Pe2RDsNrShXzVdaxdJQ529m6wrUi8/kN3LRLil+Q/I0NzgzZJX1I30TxRDroOFXX
ctNhJ4sdrhWzXpEd40hp7kpnfDJruWb3076MAzTdcdCqy65SZS+RlZfBmB/agK7IFCoght4mEBE2
GiQ4ptUwUI1DiIsB1mZZF2WoXIUIUV0pZzG1m2jaiMpAGQltZaOPynDrD6NYSSEvY5im9z3WRQ81
329bjenf4EI6EGVw3WaKp5KYlG2ehRzeyaiKicZAn4DZY9z2JbmRPTAzVx76dovJLtoN8ZggYzUV
ki2DYQ1EOMXn6adrS2eemnUA1tBmD3wcDYXzQ5w2hyhKy29GmcW7cjC1VSHX/SVZJ80TN37cql0C
JKEntGodW3+UAmXNLRjSI3l7McycxL+DUTRte8AX25yCGQBumyADtiAKndqwOqqx0j42ha1CdYwS
zxG5fYlNMdgYE1snTZjNDZxVDgMyAVU/65iDxyapxv4kIKBVbFa78oeVVhfDYPzEYiCgn9hhDhPA
KJtI83yBynXexxHCAbNlno9093C9ato2y41uXZrNnMKYG84qbQco9zpzc3iowWlemj1f5s7ULTcD
ELU3GjAkmeWEN0mum2vHFsUumSLTNRTpR1o3iZuVkbOZykx7SkqFs4udhRGADbgsqyDKZ+JELLOR
cuTIxV3duH5K4tYqbbRkj1ZiXHdZHN4ogkRLcJuVdRtGDiEQlX7b9diQgxDlL8u9fWNG+Kd9i5JC
WZWgAkiZsZofmGxQC6D1tA+Czd9e66RoU0ImIxEZO5nErtpLtVqQ+9e/aINsrMawxqZZJ5QmdKj1
yCwyokHY9shm4sBMEdo+FtajY1q8LXbF1fcVxBYWNDcP/R+p3+QrPdFVUgbU2Ev6eSmEUOIKMw45
NFE95FQXXmaNRf1LtfzsKoNtGnsOyGI29rbEL1VStjEQ71gxjXi8hCEI+FeJjenSVsRNUqY/WijA
u96E7uG2GtwOKXWqbY/I99Ya5MoLIVqtsQFlGwIU+ToQ0QBig5kJmCV8YCeAcAai/YsZBsOzJfvd
TTfGxtZQihzcYhNeAfTG+hJMhkJIiNX5Gwjr9QWh755jQnchzaBgbUU0Hrhqbmt7Kx6snTqFmiv5
8GPZhXR7NWqt68SvePnzGdvdEaIGIrbMvKoeITravnONjgcar1H/CCzrVUoRYKkcSg4DYbuPjmpL
22qUiidn9CGHoer1UIWIVdg0jJOFDZANX0IGroEmYaFYGVIp7WA7oAVC/OzKBBl5pR9UF2aPA1bW
SIy1qQ+yuEvsGMB9croSo7TV+55EVxNI8I1cD7ZL70tdKz6gSiOIJzdLYGgTlovsR7Mmut5s7pww
f3UCwHSiIHZGyQPdzdnMeZFuDBCFotELcW57pSHpXuG0041qjOp+isCGA4AeLwMtMTl2OAIpUVVt
dUMEF1VtgHTKDBuUdNReJ5nRbrHVtD9HdZwIUJFV2n8cb9iXJyNs++gxV46ISmALA1veZIRGEQfa
20dQWIkXDwn5A0w49YadL5S3IoSt7BTtrVr1r11PtlTYdI6LZni6UMPbNt0Q3hyvOB/xcNRE+cEO
t2P1YWM0TROcX01rr6pGWOuQ8Tw1UA1XaQTnQuAsiReFYeLJo+181wsTHJIRWcmvybeesM339ymy
7X0hj3x45Gwsoj2iT1CYRqmQfWSHjfk7TIxhn1QDC9QQp+tURoMvhI9TUIGqQspfXVzVjfpiapp0
AOU8uOnUqfhUQDbw5kWwsTpWhknAbUsG82duWs1OSwvKKJausD+sgBoVGhrsHOeegIbz4Mjjo4UL
nc3XCFC6FmwBpVTaWi3JzElGGbfP2dLiQIa6mRTFqiL3amPSKHWtqqlBck0n6hsdRiNMkojxzWut
A6kQWUihlS7h9bPtZhvpfrCzy7z6Fqq2dctFaa5pMVEjG79s3f+EeguQQQcNJLPLclG5AaVrunZN
g1x/bCMRrccm1X42oapeOXGiRm5JOiotzZTQXtbbY6fjNk2bGjql7D9CB8A/EkqEtrLQeo0O1jdP
K3VXO13gQZD5NVVJtwauCEHI1lhZsXxtYsfyQR6IX0NXVfcUoCAmEsW7QcIIEFjnEY/jqH/LrfB+
intSw8lNwVBqF5CQxsyjNMmbZbavvWqlK6EkYhe2lc7SxNOTIZbvi9GovxldLh0ro7CORHSEV5ae
TpsssZP1RLAGZV3BZShzWUD64RRacZ1YA1vZJq8o/enUNgKfF9V45rvzShQjgFUkYyv6yZxLpQHS
QG84njmbZIMosvi0zhlFpt1eR0A2Lqycb2HuABsTihmSxqaW60B2npDWlxupzQdOj0b9NHUUKXHN
sQGr+42qF9kV28bucciBs2qVH7qcKgt42Ua19bM2mVF4nBomYSY/JsBHmzzv2IiMRrbmvEMEljyC
URJNGu+agviewFJ/l2LEVy6maSVKA1aybv8WQi6J9EiTwyiNxiWu2dzTmx4rcBBo1bcyawcO+GkD
ooGMb1cj9nBjQ7ohKtevNwJshavF2S9kQiGvbfUSDpANwWop2sHMmf3tpDzPKCkXi0+xsX3fTNya
NLHXxCcfs6gN5TqjL78mnYVqnd5pXtvMwPrYvrAmsiY0vHQHx2ZRoOzV3lhpYsNEA6aGPwBmrBRK
D+lYy6dOU8JTVWv5pZPY1nc4GJSvOLa63FwChdDBbcATGjvdqkcPKIq2Jm4oW+smzHBZjRtPCloV
9GpRZz+axvSPAK+rXRgq5c5X6vAGDHjt5aRpbwcey6qNe/WodTyawAxUF5irsS562K2ZH0/bInbU
owpyC1S0AjxEI13IcZRi+yeZrgrqzZRPT1LYWpRlxWDumx7pH0QdhGbs5zZKDRWsFlK/+z+OzmvJ
USSIol9EBKYo4FWAvNTevhA9bfCu8Hz9Hu3rxOxstwRVmTdv3oNPmehWN+HrKCbMBIDKD9Ms9m6T
PreSgLCk7oawED0dm55kBxYH2qsHaedo0kSdVsL1uWSUIf6wUjUf0u3fo6ZITgaBs7u8I3lzTrOf
uJsZxE/IwmK9IbGjfrC3KzS4La9VEWALR8dqaRiEk+t3MI14v20StpbY08Oytvo9L6e1BZ0nSH8w
m6Om5urJjDLnfV7df04187zonDfEhPTb2iFydNYq9yDstuYsaatnjBNdAOmVk7qCp2rkWvoxmk5/
BjNf+HaqAd+gLPS1dSUPpCkIoii15mVNewBeyBZwiWQfRU98GQZtYdF4MKVJBHOMZg6VZOnd6KT9
saz2eMSzMxCLPZs3h6o+vXD5iZvsax5YedHvkgblgiJp3C+jc0sK59IEWYIfXJA4WDZ0CDaK/A+5
SolHrG5bficxiX/VUJR/yLJszLmKA3kZZnlxgbU+App3uEUFgdyCXdSM5LxAHyOQd17ubMGukjUm
eLDvCPBPjriR4dUQQ+670TLDf+tH+zJIlLrVJDS77ox38lBYm5jbX7PNpz3QSIL9pO6IQ2/3DU5P
VqFDfWqqrWVYycVU9QSSwAG+4QHxUa0p3uQi3nEX61RyzaedJx0hWy26AJGJ/QEG4ns+Wiaqi7jF
0JSeEWOTz6UkgdmIz65H/ml1ywzv9V69m3hSwLCXXTAStmNW77fU6Kl7MmvB1dBX9p/LoX92yumD
rILmCBlyU3UIUeibH2mJ3W6OgUWiK/Q+NEh6TsCDIdwNzl8q44/MIZDVLImvwdOYPY1GrZgftGgP
qnK2UVYl+6kxTL/Gv3cA91ceO4kFnVfOTlj7HygeTXPwTo1nNB/22qgIqE9nbheRvgxeQvNiTR9J
c4PLiFmnubJq8eQiJWxKKWbbb1vY0LuyLAWIkdKKNnoWPTbJNF0cgp1yCI7Rql6qYe57CHTz8iKV
a4RNHzVBk6jV19vE0o/E5LuHGcjAW6T0LuC1xaMtu+gQLyjKppe8MmbQ/cqNQevBjt5FRELtaX2i
A7vSRmBn8fTi1rAmV2zWvhZ3BAMME/KeN9Y3tIIdtG7zr9Srf3ldGj4p9yQu2Q7y22mkzVRhEQ33
hUvg+eDCVoEKmNFPJWbYEjOK9pv/GwyOxbEpC6QIwaRFH5zordWXmrJ69to95LTQyz4R1+roXFUD
iA84KROpCWOfpjuFSf66EuvCSphIdywdpr5L1OOmyhUqWGlAlpKa/FlzQBPVZPXEO9XfURHfJMtX
9VZmJ9lujafbL0DWR8B9IeVJkNILVqoGlTMThKUTA5NhE2tbUtnqCKigYbXGThpQF3omTUSeAoaJ
pYGm0SxeuDRDf3QIcVnjUdssWf7CHvdNjVPGNitc+xEI6r/FNE5Lnj+vvPA7nXVPAHoI9gXUImjN
FzEtBqDLDtCcnv4CA2F13Tk5432J+comQx0l1CwlRXxZRO84zbyLWTIE8p1FS/4aMQ3PmXS7T4Pg
48BbSM8i9sdYud/Jcwizsh8fHN1aj66ZfrpW9xo3Ovyhgkyx3hiRyBwNqtBcK77gKvU90XDE1MSL
bYSZF3dDo08nUZMQjG48bepUA/OuoVZXKcLFUNUx0nCvttmtbSX+kxmKRVy8NYJZIvVr2hQVdMrC
QPZHTCoYf3AKL3xavpjIPx8bc4S4NaRbAmFJ5+hKUH8LFoTSQssxVtoHp6rHZ29IqoBi0DmBD/vg
PDf5c+n6FlirO9A/WRCxPuRXpG9IXnxSgTY6CyrQ1XjANoZGka6RVI9ExOWzKcqx+y1Z6N9YuVuH
dUexRsAWaNMp/p2dOQkBvK5VyBDkveUA8hm/EKMazV/Av7KNhYjEqEanJoE+sjU1QZeYNrP+Y2hd
d2p6Is8ygI6bGJmHZD4P2bupAAqhJTxYS90/ZmlC0MlIrsUj9IeK2nhtWn+ppk+LcyoowNr4BHJ+
uRqhfsqU7UJgSYGYGK9ReWfGrnFhrFNfbA4TfhL7X027fMpiuYAzsAVzFY84ks5I2HU3mNyWUU73
XnzocdzuxzbzjijT//pkmFCIM5TDrGpvmVH4SIOiH/un1tNRc6NckaxLYnpalLFvO3HyPDbxcFeV
6gvckhmK1mM9M+OyppIrNjnohBE4hKMWZjTDmyihcJH4Xl60QZXNqTTz8qIzaHJIVenne5ars20+
QojVCKoKq1gvr9ZcmHcNUj/R0RXVoj70LxOhBIGVaTNUpOaGJzNfa4H8t5hEOw22nR1Xx8uPUr8V
3Iovg3kr/bQZt9s2zpNAeRyeanTUnnkOdNa2SjBrzMVBqz2Ts6/SNx7qexBl9rtRFa/Anl1e6y4J
1zQy91BjwVbPJhVc1M/ulknm8jhabMH1zmQdyEibw6nrynM9KyLmO5fWlr9CFD75wbkVe8B3JUvC
Qs4XbfXckxPzX7jQLuuOgO85NxgX6GZMDqSCPag5mAAUsWAWmIaHxFCJCvRIKm+j9Dy+KEA+jG4c
c8O4fdwWXXTPcSKgrkbGURpFvh97ke5voAnaG6jvRubRIoC5C/MZTAp5AY0/LahcRJiy6mpjRCCl
RjGeBDk32lD30huvdEbo3fYxsrlOXsSnSTHE2CPO/dlou9OMC+uk26n5lcNT3YACQq1RpOeS91/v
XTEWDwY12S7Ohoc8HrNdJltAaqIwLn12W2UX1hiQ3r+eWCoXRynt5iA0cn1qNwKJq1L1maRpE6LZ
Fb6g+vRXrzS5Ujj7l8rKYS3q45M1MqkhJbA7Qc/CwRb1XWhX683CZLDsbtg1I+K1VxtvAUXq5eu6
97xYhuMokt1UTMye17e1HdUe5F0dEqU2PHJAL8yRSEfJ2qHYW0aUnhtTNSdSAMkrt8b2AbnRZdy1
DBR2K2PaNs7uOjU9CYrNvTZT2xS9JgBU38bWQv+yPdVdFkGQUOX08tChfjw14xBtdYoK36GQqUjf
tZKsvFOJdEPNm37SXE7v8VTJZLPcssxkzlHQTPFPOS5ym7tpRMc85Uy7df6D8Ra4XU3igSYi/upt
q9qBSAbi2edMe+M28/PMGa9sVAON0lud4VnUstkWe0cIqd6RU9I8xHnWsAVdEr7Y5EC2uIrXLl92
CK4qoK5v71XeTJfKKPO947rDrTbU2ANgdigHbdkbWlPhdZDUxEsNqGVako3M7JeiGbwdsx91bGR3
YxO3Oh3vSDSF7MmljzxiAuvI19JpvjZzXMOTuQFtLK+GfOn9gUb/VvQhDK6/bawYB+lqxdtkifxh
XJbJ11U8hOSAiLsK4TjMR2a+ph1Xx8zL7SPBxukuK/OXTDgFzaehnzrbnPkAegIGq5ykQEY5zKHY
9JMTi4aMtZaDaUfxWx4vP1XffhAglfhGWRElVXfpltmqvnV06iehwf+7obCC2Xb0uzhikdtz8m5b
26u5gaxoBilnz6UqugSBa2FyLueXsS7w7nsJmfAMVa+TjEogL4b2Cu3hwH7qdamNdMuc4Aqf3aVT
sj9Hs08Ce+F2dQ0ecaKVk7PHt7qjNzOuHonZD2z05r6YiQZlO8fbRkPh/lCkGTsd0AyDpJxcTM1V
h6UjQtFa7E+CL5s9W7f4TLwIdskwW5uKfnibeLbBq2B9uhmTv8ZWrZ94t36s1d9XMaVnr4qGI40M
OQ9MyVNuWm3CnIYikJJE4Bui4nFpMusB4HB+MRqC6teEOKw1SdqQ5ECo47Uy7liLy7deRUfItlWy
sSWsboKQSpZLpEu87PQ2IZhueciSAK2LhE6js/dr5DGXl5r4i8gGur0I/Pf0GT5BoJBsHO3Hplkh
u7358GbyDJNpGC45h/U+0/h1YgvVp+nEKw6D5BbBtUIahPch1/LBndb+TfKjBShSfOO6GZ00OOJB
3icfeHtgjAi82GPqBEacTM9u7Tj8FtAx7BxBiYjR/tD0zrrtCKR0+/G1jpgyZhO4UUMN6WZk9zRg
EhL5rhrL0EuM/mAORX8/6FG/6/K0eibq1wpANZo+qzCAuxUlvR+1k/y0Tb3bj+5ivcfG0r9ojRuT
J19D5WaQ4pJ+VqDj4R/yO/qp0E0QCJeWMggeBsyjRg4PyqrWx3EciV1BgALoNWwSNj8vlmy7L2i7
1RktSjD8d6JnkkB5d9uJfPa48if6BKaeDMloOZX+nXcubQ6BMv/WPmrfC8Nd93OSOVsrsZAUmUnW
mvBrD9tWW5ECn/329fSWaPEzSFvgbzfnzlygAZJU6WJPk9OrG/N/IAm8DtuO0WKych0L27Tu7GxS
//S+HV+Jfx39jB4X5swyhHQnOWotF2sH7/hKhxiDnxocf8ineJ/k5RR4zmCEsYctYY6qGJOZNJ+N
wfpl8SEj9aB3drNpZb5htBErhtySnV0bDxkF2aaXzDXgk0GINCl0WMmFHcIUY29YDWN+DbevFU2j
D9AafEGpsmEzQhJ6xyBlbtPReXE7aT5aojH3tFv4dmTecsI3XC2uHZ2jrF23y1RmwAijp5R4/BOT
xPKltzFcVItbnA15xC8FpDPXsjdwc47f1E6Fs4yWR7jYzBImOY9W/skCMRrOAwG5VAC+4m3VUZxT
sjhz7ADTa1ZuDYxGjBcvbfU9Gtk1WhdoG/dpce7Vg26e0GY2NSpBHv8AOeKuRO8tQL7cpv0uAPIX
TI5bW6q9kM+gE6HfGkFuPzXGybYRIO/i5OimewAlKZMlHZKD5+7tlsLuDJotgpHnlRU9j9iU6buA
KmppfLz7tdjL8sdzHui1NqlOu9CdUR+Nlf5HP/XondUQpopbhURPvq2vynmo9ReLRqq6S9Jd5yDp
2YelhjtZ/JbTvkB56jTfxPBd1ecFKSllefP+NooeGDoWY+9nmMFy7jbV/xENS5Hw22kBPBo1nOfy
ZyDyz4yua/xtlArGKqRGDx9LorZx/RyLd609G012sJljS/HgtN6Wa+9cRzffTR02fPIgSAK49id9
2M7dz4JoYec4HGmm9Ol1QY7q4nAaMR7QDVlUXMjZxbQ3sqNYTm7C+FUUgS32evFQNc8Vr46iu764
Peo+SfRgRILGOjP6893eDerx5/atyeSPzhKAPUGeK2S30HbvavWmc2DGTX7Mzd1knMBNHsqCTH46
Z06GQf/OEtjlGFSNjkaSXOfpKYpJdBnQUucfTqBNSWL5gAAnmqOauHjAOuWEjenVay0PMgUeY4pN
Gk2b1jomeJB4YrhIAn5qlL3WuNf0sxIfcX1fGIc++blxi8hc8SebD/CimRBLL155G4J9IKxMzoMH
dbfDe+l8C+N5mV9Jhtkw2+jEJXJ3DdMstv41bDo9iYUtLouwN36KDMIH1yoQnXTVwORe6uiaCuCs
uLjyi8tFLoGjik5vtzU9LlgnXGFlrSkGu6N4SUa7OiDpfpm5mV/Jig+dlYYqv0zlc+ICe6b66tWM
SUrcu7bml1a3yYvziletg9Qjz5HZnhLS2o1iXzjVZoLyS9owhDAwkQSk49tlonRbcJsvFhxTwZHn
vYwtJ6/HeK1APY02YnwBhROQsu63lINZvksZN0+E7eBv3S9xSrrT07zcu+VFgmyc6ert7j3T3m7o
Isa+rnXJx3jn5ST49nf2/KJ7j220y7Bmrs0fouROU6/6+mh6L7j61+JvgmwW39KkjFvK6l4fM3xq
uxszz7QNP1k+0vYlhRo+6vsong9y0v0csEJbEyTmAYBCqadaYGxwWPDjCIxxHkgsVT11xmtnBZbQ
rnhEwtq8gdqA0qW/YvAY4pcAqAgrgj3fjDf5699MpnWZnVe+rSE9NDE6zhL57AUgImn32I0CYsxn
dp4878fk1FjEvSN/sAX6cQLaySEVGpV9NXeD4HPjuF0Y1R9u/khGlGVy8RaDkoQDkWeAPinQiipM
O+11xJgGL2LjRg+5fT8n+T63Pk0M70sF7wKzQ9x8TjFdXP9MYPbtKpxvbb9gPUHDINBsPDbPs4KS
tDRwrjx7qFk0h9DRquVCk7ttJsjESXSMwHc40aZPQSZB6LNCLTu1ZPa7t+j18d6QgDgUk3HGQxSr
HPhtMNXrScFmXeBrJ3YQW69V/aHrfBQzrQ4GgVqSoLllxMk39SzjjvSnKxgMQZRZ7H725s2ZOl/z
pQ9KLfrXjU2Akgz69CKXg1a+DdO3re+XcmdQLuUktXtftX1PMJqfQq3IrZqz+ajoCSt7V0EcneC/
5gZpaA9cqGm+Q04sJs2fne+Vw3Zqv1X+7NhnGouN3XzEwwfuspAlPEoeJmXGdc3wte8n7eLOexJU
e5cX4X6A9lq+a/UHGlXQCPpZ50vrnmJekT7dluXOzF678dupmt2C6xbzAZa3J0HyZovlsNKGI3ga
zmry/MovEd87HeH49YFpDKm1T13ztrinEmjY/+lt4CJp/PiHMTaO/xr7/sbi9rS9LR+L+Y9RR939
YLndQ8WhVy43uvlTLnDHvd3SnrOWW5Pjuwe64uBctLLdWj4PLlbZ9U7a91xrWyppnwzf6K9FHvkD
meFLhDxtV8Wv2figL+8lrhGjP2lUV7Hj9fub1xi7RspRJGF9ZBiaQhCq/bEABbrj2+8Jy6/rsLJk
cmqt4n4iLYYvPtlSuPhyehgnzIQDimB5NTz0xoxsntd0gixvfzvzb4chJYNcY8/ARlbocXwlPAz+
kv1qTBlcSKE9duspEUEl/i22tkNKhHv3hssslBERsRy56yzvop4JQW6HRk5mH+6nQg4fi2Ftu/hQ
uu+MB2iii21pvyXRr7z2xDnq5b77cg9tfycb/uBEl7wZy13P/I2NycOUHCSArgZkSLKeb96ecXmx
OE7zksPidjKIn5ILKpqZUiT3TkneBwDj+tEFCNfkfMkfnF4eDGvox1VeBDLf2RwqrkEayfoR20/d
cM68XwBexXiM5zMw7I3sL7c3jfkzL9HBo9Q2r2nzGJmM320nBOXLv/ZbF+FCeYcuMnX/PNQvZibc
OcpXMayV9CvLLw1OA+J9VxkO5ATYV9O8W4yD6mhi9b2Yne3IfWG5R0Nj+tBtRXaVjESm9QG/Klb1
66Iel+nLMXhiPor0U0ts5rF47CFQNtplaANm/SGB8b4+fkzOaa3vCVKvGQM2CbkX4Nu/0Hm0at4T
pV+2z7qFEfNLd05SPEbTC0zMOj6s9lYlp7J8LNcdSWu+KK8eMmw93RXZvcB8m/afRdrzEJxs9wUk
2Mz1lcZsr7zY5nOc3Q/jWY+Py8011b9n8kj08bC6FCphSmAXTyhUgEfPvM4mCaFbOdq8j++rcecN
IS1cYPffXERMtgOLW0xGv7PMt1Z1dscktAswXnoRKvL/6fBF/5DkZNmb4CwysTH0rWzZm8EnFXEr
6zfC7aWE7hrXh8F5zPTpPJqf8RDtCtNDmAaDq660Mr50FA1PtRmZV8z6jpAl2N9NSH1OpYxSTemv
SX2rl/QjybWiVXO4ed3qkQQ4/Kgv1nI77bLjDI6p6L5TjNRlBSqoOpTGbzI6m9Z8yzgATD0jDyvz
UaBLKveZ2WE8/Q5LEmjpQqTZcpd1JWnXSLYG9xu/vtG9knbcAYIbvHt2LKgF4u0K+Heh1Jid0AFs
0MgnU8LtmLrHIQZLtQpOmThQ0cds4+OfXqLmUkS2r7VgZRGpVvtv7MpgTZ6m5itKSOLG5ZlxHtTI
lUoLUv2u8+z71cvPfRNvJ8FVFZebSMM7zYc+lWLvmfgVJSfeYL60BU9zXUBMir+FxXwq+23HiskD
Ln7MM1yFKnCG40jID4NszlxgUojLFf9khZMlGoDNIRtl6mkc30Wzk/0d6CWsFpzY0VZVPxbjdFAB
DDj/ajeUA1EeUQQcJKMFbw+JM2xH46dlDzzyoFxL8ugH/D8NcqfOqs7GvFl8tXctmw91NRwwlqCk
zvGfinauuzdwu2luullmLrLkeTHBQ9QqRPI798Sx7ZzVxmH/17jA4dVrL61XM2+/Vl1uCr3zhfXT
ln+J7ZxsOGwxUaRl8T6plNYc/xszPybL6wiT+r7RuHiT19R7SUwjHBQ23/XfjAskeq6WP6+Fa8sC
jvExQEQY+ImTvVgPFasvC+1hIT/j9SJVkK36fnTG8yCfp3YrU4oUYtYzbWMwAKbV0dUPgPSh/bKt
h7a+rYsxmTm19bYw7gYHzsXBdtj9B8VmuyFeCb+nOJRVuhugvE+4/Ez9oVenQZwUQ3CZ/JSW7c/I
xb12MJmLNki4mfHisNuvGTtMoBudJorETRggfPMssOAD8NNbK4ZkM7zOFli2od9YxcPs/sCw/bdC
cBMlJERxra1nDKybtJ5RfH4540V0VdrJcA5lthtyKPT8bAzJ7fXRs/+Gnl2X+b5Q2zJ5m5zIXydO
IzaTjhpPEdMBoHpnxs2W/VvFDa7RZ2YjKT43dlkIrs2KP32+6O2zjW+1OhNEwsyCB1q/ygaT116B
g2vdU9PR9NjnsfyzGCfHIPQUSlX6LAdmSxDMmvY+ki/5ZPvjcu3biOE+Zdmbgc9rISfVQVSn2+MB
6KKLAzSkrp7KEZrKk6sep2VHbAGgcx/dF738aBf8heZedR8mrYvwTl2qH2pkjHyhAmL5sCxeI82+
m1PycU6sCTKNeiycUynfM0hk64INXa54LKe7BA4HgOaVrKGVlTwLWbWkl06o6/TsbwTg1gz7uLlk
kNjTmv6W27uqfjxAbgWjsNTYwem2zISdyisOp6DNWBiJm/2Qvo41sFddMar+Tqcvj0XlBI+BZr1X
5r9WjbvEWgJLP8Akw8HFc7y6w8OgDfs2HWCEzoEBNQbkZZiAx1qBVMqWlQwBijWf/gmMfYueQxIY
zix6HdEZog3rfa9A7fyVkxqPdX6MPFR9zb2yROiveXUu6oXpOJuPCD3gBtMlNMfu2IGo4PNwFN1O
jh1QqHuL8NvB0NiQa8MyIumwFX4e63+uwoBkziHIlw8vZp8IFbbyBhAs1Q4bxdHpl31PppJ+czFB
rcUuzz4J1hqBYXr9NiLzTpHZD+aG3svbWV0fpsaNVTcGbSX27cLL7izTwa3j92Gu34XQ9t46hq7U
z3Wdb91m9dHBNnIp7lEyQ2ucj6j7HzYFovTG42RlDyC5g2latmmTtBvTqQEYSLK09UPvaucyj0+J
pW0rZv2QdcZfpcntUM6P8aIztmc4NZn+aneHjrcm9YglKq0PfC7UErAUuY3VJs01n/TiJ+Hg90rk
obLazzl3ZWjWJCh6hXc0uHDxfvv6YG1azQpXSD0+3BM2/v6W8qHvnqQYKZHXamN6tzaueGcUdD+l
+daY2R5wluNK6gvet/vCYyZkebtKGYwlgTMa3aUqGeVVjOQHtZ+j6N5MRzJoIYsMa3cd1vIEzizI
meBFOqRPZGU3SU8uB/RthnmPf/AyE2xcxfab2fSbkUuzz02W/3DhmPGJjaVgWLIXA/zDbK4v3dqF
Hn9Hxws5LLHvzVkoODhaAOHrsmLHgQQZe0FOvrNmG+euLvdWx3uKgZKoLV+5TsiY8qPV3H1eTxdl
zH7NymUHb5kJplEHyy0iXjf2Us2P6JBv0zgcRR4F1gpwzIjhf68MrbG3MdGsqe06BHnCr9wF+JYQ
d/rwM0T2zjO1fcp9kuh2aDNfhrCMSKRvcbeTJcYVLHl7CYI6JQXVe85aXC+Ne0sfQ/k/JRTsmOgC
vGR+kqh92/VQUfvdoM+QMcEkM81LpuXgmDXI2Yp1xdv7w8/OxYy/+dcDrzwZzrEz1oDk6qusqdhG
c3oaUY96p9nGGmKcjuQz23NQIL+jSf3qi/eYkuDs22PCLyWLX1XzfbtliBsJlcmj/sFiZlFCrjff
dy+iJQSKgJUGp8fUZ4d8KgJPFQddr1j4zHbtXH0wQS6CaE1ifhttqxRDmJvD0KwgSEGFDJxphngT
bRkRi3AghTDJYghONTzeiNtA0peaMj3l7gTyMt5F47wEgsCpDhWimJtTHXOWu+uLwOc69hTELTQq
4MkMvsaVJ9FDBtR1dcJNdMgXgGZs90VeQkOibj32AZ/QQFunriSJPIFnDgCi3gEjLTYZKwmlit9a
Hl7QXyQBDw+V5YCjEWUDPC17svrXfKTL69iTNyTLgnycHBlt82T3+Ue2SJx/i48Jcj+XMQg0Kquh
oaxjRxS7Y4XFrAxmxkmRUZwVc7Cm50im+uHxyLg/2qG5W/BIdgkvhVH5Lp4H7KoscmMBXznloxSU
Lm9C01Jg0ODYKjlWUb/JMAVVNXNsth1gHmOAhNJUcxER9Y7tGlW+CRPl7k2UVbBEYTbOYd47GzO3
dpDPAtOurpSZRxZ/6bQoinvNj8kRd0322ZVkfYjlS4e9yLRCCBNQ65kMYCzIat8u2NHq26OXjZv6
1rMlRoyE2O0FVa8ayj+waPCPrfXdmBi0jctlpDNc0WMbB4+zC5VCTxjPQxisODEl60TVkCPpmSz+
kap/MT0XV20bzlF96mgIAbH5hjZtORkON+f50qnAxInnTcVrM2THYc50H3fs3ZpEEINF+VjbmBJx
TNAZssyWieq9Y0GNfo0Ji4UDNjP0Szuikrv8oAVuKe4SBrOUZDZvX7JjUyucMma+K98iiigrS0EU
zT5R7FsrcjaDdHEOAPsuJFtlTRBPGMEdtPi8sdBMWFHl+1wwNKVTNm06LI++0jCwr1HYEFderFPp
S81G18jKQLKs3Cida5dlosQN8Gf58Xzr11vfqqqz7rJ4bHCy1F2FNcnceIn8sVg18Zdc+Ilg2K+7
+KS5SnWY04Vkgb/rfmsK8YafV1snvtDmNEsVRqseWuh6jWFdDDT/duHDiMcOlrgyT5VYn63M2uPl
3sESfIJb9cA8+NLw4Yyz3A1aOHs1Ymg27ZNFHOJe7ligClgtCxnJPeg9pSoTSJdlQUJJH0iM/Ggm
HKEuMz9DX2k4WMuQCTNjL3A7inJquGTQHj2L9m2qDj0VO5D1ZQ7sGZCDAqas2H42nZ03/xPcXmPD
r8b2Q4cjdxPVYxn0kmUH/tQgciHtKYVFvOJ0F98LoeXY67949jhgWScWeI17p38vbHtrFdndhEDX
zwnj4Iqdr/iUqnbHaj+znd6Xc34nRH0wBjbk6nFnyuyRdXCEUOayjOwPujQPhvD+WpnqOItYxkmq
pxqG1m24bukemgwvxez1h4FBeRmJ+5pEGjbq+Sm7cjdYeAstDiTbeV80FPi+c0hv1D4mjIN+RBgi
u0sz8yD+wcpkouS95U10Xgc21qY+ZgU/fvaq+dIXA8uEWP3tBuDFsPARWWO9Q1tmnpGyOahdSatm
tsDlINhVxGZ9m6RoRAuw9DhP9T5CAzazHNrTiIHHdsAJsMyNY7MYKKF7/QjZjhlA1BDOYOPeVoxW
w6SfodZiU4toUk1v3d+MmovTXRLT2xHmfHKGZdgzW/txZ2trp9l5RmUshRk2sXzT43E7REpcp6lG
PnQJtqg9eho3cJgmRxKU5Qj5yWndIL61juVCL8+aqk47IVV3bYuIDtw4W036V1vur+euFwXJqoG7
LERHXVgdJ5WHMOv92UyONgjMm/OFmjdYXOxnNxEITUkixBimQjOZ141lx6FpobzXGje2i5CLQBnf
LkPNNFnxghCsFoxGPc1HnlDKAX7OJOkZZRuH2Bm2s+mx8gHWnIH9diyYuHbsl1ezqg8iIaKRgIV2
tim6BfIKCQqrhRjejzunqHBUDhjMs0qQg0jyzKO2sK6fsVl3rRsJNQtEC22S/uDxgjZFqfwocW/z
odF8MNy6cbfFWva7Mk3Y8BwL9zvr3H+60r0ruaMMHwwi2V9Xi/mVaZ+7LnPUS43j442kqGI3LdwG
kz1ghJY4gyzoXfvIAa+4aev8K8us4q6WWL7wDAEC2kVJXJ3FABqBvQWNbsd+H0bRnoAkfq95N+xY
N0zZIa8k23Eqh56dRHeuYbDyGa8Jz7SVmLjvEPJMwit097VplPnOfr97b4qlzP1hVuZOoGn7mhsl
O6NCccjHKDuOpn1sPHa2hGK/ejUn43/++n6uWSRKY3SkbhXsvLGOuWcE24dt7uBW6nDozZIt4571
SGxD7DCxrNah3f8C/8RTm4FDtFzH/AJqj0NrxAEfNz1DviyOjl1KU1/mw8x6qmcyc2Kv+hEXWnLI
FBsFaCRpixrbZs91iUwn2RNPgtRDOjY8i0QXk72ch4xQDpcwk3i6n5rU+ZalTWbJMqB4/kfSmSzJ
qWxL9IswC3qYJiTZVt9KE6xUKtG3QUDA19+V506e3cGzI6kKgh2+3ZcHnf0EqNB9MF0npVxTGi4m
p/WFdX+SZRS6+6sP8EHSvjlZNgts2DLNd2BuW6JKfnGiBuZBDOlLaWPJMERJdJ0Z9ABpyrisXZzu
TFOSk3PNn/xt6v5V28T1tuCHBp/comYyxr9ZZdFEkO+hq8f+uCjx0ujlby/G8ty65l3j1mA6cp9R
sGwrurFun9opIHLsglp5DIveJ303kZQcF/OTlXP4ihVZvwN9oaipqyBAEOu8jHKck4yuzosIPfU2
SYv1b9hsBMB8Ajx4sZ7Kytj+tbKuPwWeyMOw6fnYsimlHMLDQF6WKdscqH8M5ott/PUkHv3QUK92
RqooCCmiMisCuqrgbkGQ4L9HvwVTwdFWlQNZ5kHwB/fLdyVApNzwz0d7tV+KYLAO7oJ9hPmlr4wz
VhWBQC0Rrd2s4aAyEYbRBOt3MrU3t+fWuklYNMUVU4wVWxZrip6QKjNZO+nTbDV4Pjyl3mY9k8UI
A3RAEXZv9Gczos4G53RFmEXs6tIhP1eShce5KB38IO506G6rnn4J/T9hMdb7W+QLRMA8kEqs6IPh
X13Ede9qxIyMqbrIg8gMvQXRliOoheT9wh/BEWWx/u5Eo+4tBVt5By6HRbSXkatDXDjIufihaLHA
0LwgDbVVSDxhYPmVQ+xi5dFTWV53/G1MWwZ04og+rpuVz64EALHm2OYDJNGyVOuDQX8v7dTVWRUL
3b3jDStFt2TpM134YX/su+rbTrfXptIkV+7mwnsMcsD4xDShdIR6xeeHr+aYjR3HudW/lMxStHTm
HKfNLRrtpm77VGk74KNEIxi3Uic9KYtlAo4x983QCmVza+gpTPlJV2lIGkR66+PkNxTTdnOASxeZ
IdaW8WsOucYqZuDPajU7wpbWfFregArkc8JffTwVchs4AtBgmQpVFze026aII9lfO8x+M6Nsd6Zu
u88acchZ37IaKiCTeQ5rIwVzQOo8i4ihcsg1afpvFEP9LFSQ/kyrZ2ZsxNPi5KfBQ8p38GVZnPHi
GJgKG4OSXKD3IWfK7eCoN3Ov3SKSKWg2xlonIIVaj3I+gZFkrZ85yCFMPqUbiXwJTboFlaf2cqzB
GxCA7Y82EaKIfiBk1jVb2ZKUgxhJ5SK3ltrC6Yh4RaV0lif8WrOTUQw5Hal8nO3S5AHcDNO9LFAe
8DxxW7jW42czfiZERuIFctzd4OAdtpjRtiBlOztTRmV41NpWk8Hg7A3bp7Gx63YWw+aZcH+vmqdl
sor9DFkJJywXFwqsUuR8Axv7iMzV2/L3cqOVQIyT0TA66UEaI5woqxwStUqYIkOQMnYsZsP4jelq
KsyFutKa8Y7mVQZ1En00aQpYVnnqkcfF7sObL6oETyzvkGrID7Ho3o1WwQdJpSzPKLmLVSa4yzRM
ypnhf21kHeJaqIzJlpY5JrkQpSolBKKmuo36YgVddDMFpiHsFZx2QyTzMcO54D1lZEWyKO8xTKhx
SncIXGW3pxcxHeN56+/6ZfoR1BXNzx6TGR6EtHwcF7s+ydFhWUQ+yUFNz+/tCa80KUVr+dfwOYcC
Zlt/aOr+i5QV7vul4YrFxF9FYcr2L8zm8+z/wbyLuaAZwFoLwzLw1lLNxFe9+WgH13oi1aA+gQOJ
aIGkgO3A+j1NXWnvi3oxGf4mYGQZoLMTi4PpFGzYbRxKax6Hm+2xtBCqfO43e38iG1pnfImJYxFU
dmT4ONQWFkZpXupKy1v8qMdcWQwIN55BsqavP4OtBtcT9F/cXhWmpKzqefWZTuYxlVbEgoBYf1Dm
1R3sgpHNbB9E+Sirh37z/qWquM23rv7G3fu3X3E/6cF/CD1D36V5SozXDLkt+WKYpz2QO4fvWe9J
ng3CVUhViPtae7eteWiIo92V5leqU5q+vYxCrTVsHklOutdGwXPYLeGSswe1tPve4ILdQwNAP6gM
YdxZOc7HYCnEDTLE3UWjYWxmHYaXzvPK8KnIQnbWDsXeK8kRhCR2JR6olkyHv4YJwybsCi9x3eIh
Q90elBll1mc6cZ1AbEm7nBWBDq0fCt+foYQ9D45CJOznR3sxru1YDe9p6pZ4HgaEATXbfPdKxSZE
zn8bSwp2x87bMuXswfzmnTbd/M7JM/Xmcg/hLq8RbG1C6msaPq1990yg6rUOSE05JCX5lnOS7rZh
+JggKd83JROg4xkQjgpgO5XTLb8GG1/qNyGc141gYPMg+vp9yG7psNVnrdUuhkmJIMPRjZ7URIPa
WBAEfC0CFIpdM0//6rb5EU7ZIkrhD/JcVtEDbCrelTJTc9TbBmwGwWOaHswiVXsv8B1M/DYD9zIR
mp6ZS6NhMNqDV6jfLiCTA3yN8LJO2a06OMTE4JSw3MYcAXHllhQB8IKmJm3rqOwOy34xh50Z67Kx
TXatjklFbCn/Gbbf7Otqht2wYbmuN/+7QJFL2q741fctMZKVC1BfG9uuBNsSqdUfEBE2dh4BFIx9
u+bNd9+I5gt02s3GXaFO7p2RzZmf+VjvPafnzLZWtpC28vtn0ypNbvcipxVABOUrsgY3T75g2BKk
l6H85/NwvAVvqiTNDXTVMtDmqSvbhUE9tdwqUZPLPyHDIv7OHcQ7jT2JvXkyMQ1uZukl0B4UTh/a
zXbp5myPZrao75pXu9obgfEx18bvrdX+AZ5cm9AyBkXKn92f2a5VF7XW8rDMcn53zRDfsycxSN1A
xE1F8wzXRPnKGvdVkIyM69TwiSFZUzLUrPMZvXOCDeIdZFaoT9aabph5gp854APBhccHisENOhng
NJ1sdyP3Wwdr8yBXNLjBDyX/Ty43KLjObFbS8i6v5NM2EupjjrMYyqrBeWrylr1Eswr2pcxNu6oF
+krmGZNAyO+EZvImLuTko6MMb6u3BE8GddvJnM/NJfWUtWeoGdA7qdQLXMoDd76Th8mQhuNPdeO1
YT9hWJx941GBmvoLM0tfJ8eZL7Ylx1OmgzRG/kGqDCf/6DmbExuNmLiPCHXlFeui2uFZA5e1HD1c
SXdz6A2nIiiCUz2O6ONOSWZ1mTqkM9Nh2aHbh3HhaGlmRDbkSvsmHBM0GsGUIOkZuDtvBwf4p/kT
yI0XVb5y77vWGn5VQsrzMIbVk9RlemfZc/lxqwcmt2uoaKmKNZnXit0TqKuzz06DwVA5ObGTcT07
rvjesKgZUOF2oqNVrilD4zSTMj86maX2LgpZVPp2f0QmwbRgCY7zgL9amtvWeWkL70sJ6L6rWyyx
BeEgFkb5Vv3f14U/kOwCkT0antVeFwY6W2imiTmbP5uaPr2VrL0oxfo7QL652JrQNtv47kzzX/Wy
CQx1otb6io/bmyICKeyeZfO6uQVMGA+d0jHwkBle+ad3RiYkhq6dDCfnnz+5vJOM0VFuz+sz0S0r
0iyrdg4u4R0LfXTW5lyE6w0rZPSRroqbUX2uOfy3Jd9LbP/gfxjNppTAkMx6Mwl0aMZCsF5Vcu2P
5KcxOeBtadxpz9sP8SPt/ctI/8u/xSLXLLXigjQVxpYUzN9/KxhNjyuI8bjLB8Z/cD5Xpc3HWjg/
QMzkbswntlTMuCFDQ+WBYJvbNNE+oEzdD8ZL71duXHmakExhaPbymPK9L0/1+TuDRvi5WHzDS1G4
45FM5PIxNk556AjSkPAjQ4waNHQf+TBJ1nVVFUlQpYmaTe9f4T07XXVMPXd5GmpIkkmTsSLsw4xv
hbWO58E2SoAAwiBsybQNaq3+dJZB7LlF4s+k5rr4oJN+5QJCCDLCntrv2DWN8Q2oevGMFkUlx+PE
vM2FG9Xk3BrtL8h7VbxY8rWWxocZ0iCOl3q+ArAa37A+y3vW0Taxwwz9yqzSS0iKj7DgkH0j4LiM
MERTgj4dv4cVfoileLAVMsOvrtsE8tWCyrKN7pXnq0/Kwf6ph9ElOaCaY944G2pnTZLzHsTq5J/X
juCeG5otJ2wgr8rPTFR3q7iMGLnOsECWQzN7C96msn1tJqKkfr3qaCxXdCexWjNzL0GmNBoCqy4T
K7VKop9NhasDtWWuk7FZWBXQNRPcZ7JcEKhN+zI4BB/XJl2PG5b4F4fNKc57WSehZ1NSTu7gSocF
y83S62IrNEx6IEOAqCDh9/XWG/Hm+4uPziRwvY9rb+/8wIPcVAkXv+0afEwFinxl2VkVt/b2bm82
iyS4UjayaZph/FyxJfVpXx2hVnw1xPfgshCv3slh3ViAlv34uVWFwk9vdVgIGp1bkdUrQDrUIzwG
5jgjvlvOfV6iTqUCPpOescpoxU4O4Ne2b3I5Hsolu/0J4Zs/1dMfy0R3k5JcgIX3LGZx0ESTcsJ9
s1X13y1Mx2vVlyloubRevEja7ANH3zMfNqcPiHSPbtJPZbCvucKdmz6f2ACymJJey6SQm+49DfHh
0yBcBe5nog3QQLdbMO2tBXxUvdXbG0Te7rh1i/lo2oYXhUE5PZK6b5Pe2ppolaY+sgmoot5z0j/1
zPSBXsnssNniQAIWE4fktC/KAiJXi28uBXJ4qIPOJNyOwk5yHN9WEJiU1LsMcHL5WkrZP5Rt436D
D4Dr5iLpN/AfN/7KbPw2PRiHXPp55DE+xKNmoepps7kjeoyBwa5mXIU5XzZ2UQWHPwuSdjULIuxZ
Gk++l73ZJVs5vh+G/S5Gozm5YS8vk3t7ovhKHJDu2IpL0SSFbs1H3ofbFgp1s8lRRgGj0dM4NyEE
IfXbz/hVy61dbrJuvTdFkX9ofxXnRqjxtVH9ilXIbbBZehXXH4Ndae0IAxdn3sNGBYVMBxo0j43F
WNWOv828GP4ua6Nf0OTVkWhJdRmypr9vZ/0tPC+7Z6poeK6wNIfjMBCT2tpj6PXL49a33kU3QFdW
VpGxN7kAZuysJT9IRG4OOOH7kb1HNw82lyB2dGGBAFZMmRnXnSSeM8AGxtq3LRiS4SjDKN5NW7vu
VoAOSSZ52Uyk+9gcBSNmld0eYI60dUXPmEjZbJ9Vppw3mTO4LTnJjHaePECQQZjUrtMcBSrWrlfh
p1fnt4qWsYDI4Qm0C7pjY/rA+jetKz5SjC0sheC/EKPXBwee4r8cO9mu7pb0KBrSo26DF2+G7sEy
gPuNWVAn6HgVGXQdFgkbMvugFritQJG6h9sJtvNJXe5avrx7inrY2s0dyCo1/l4FDt3CTe9TjzB7
urZlPAKcwsGS/ysYXXeeqT/XGZPxOKb2MV/qN6amKQqE8VLbDHC7ZnGGj8wT+j4cMnHd2uKvQwMp
f8kgy+67oBKJ1gvPd5gvj1wenYRKYvk59DVqtWNjlutNVl558dNsAYviYlLvPd+S2KIe9CRWxzhl
qSNJK+dsg4QDWM/3mzM8P8wk+ZZZrOnISeJqDcQfrrIoSraBY0VPtrU3eD6i3GOAGxzTOwQdF+LF
Nuf3rGzT+0Cq8doV7bzngoS7b2mKFxYc5MdHXMIFPON8txGL2m1j8Sdsiu4yd2N9wZ7BXx2AEhJA
hl26U5N5raseqQVQL9NHBt6Q6cCpXyCT2Ue1teYTGyF83rLFlTaTVMC5c/s9ZGbJILJNrkR7Hezf
7iLae545gAt5/gNCAwNbYXcPfmpjkSg6a/tXFJMdSxsdFdEj565DssbtDWsXOO0Hg2EYp0Fj7zUh
7MM80K2dDSP7Vr9DZLfaIeK324LUkDbIRsu6bAKnjZ3jQcbHiSVs6shcYFPaaRBaB2ubnmvkFNSR
5kUr57FWWb8XcLkP8D/Fl38zloP9Cm9vDyOk444YdV1x583GH7NexqSQjh7gv/bjvizN+Qx9ZKEh
sPwiZJ1GTSNw9FrU41DNIRI6pNZLvjnIDDPEIhh0czIoS3D7gprrq/wLtk2TZNgsgJ5V+tq1HReN
KcTYZHAViHOnZ64XOCpCz2oOxSb9fbbW45RgT2NJzTUjsj2DS6SFjysYNStNPV1CMrLrNVhbcF6p
E+a3o796zNH+/1CA8IZoRf5LLpZ36bvOap6qegJxzhoVdz/bN3m0gJv9mHLKnwovCB7THEfxSNH0
QwFyBXBNOqZ8j6pyJj68dh32dby7xI+4f+U3g7kqBwZMbjj9OW11/mAGZAJbRGVYJpC4rL7+ETmr
VvRsQn0suNmVA5EER+C8D+mNQAW45EA2lmi/l4lLH4YoNz2YVC/bnP3KlH4wLPJA0kS/xUTrxY6d
fdUYLE+bZ47XXLpZDIEbTqUaimjhWI4qHXqXuaUu29ftR1ZLO8lCkr6NheRngIhOrKBLX8duI8ah
Wz92oeEm1rrcPJn8Xhun+1VmAe7gwOCBnnmnbFP+5XrLdnWzgr1pDPhxGyl/W/MU8nKLWzoBQz4v
CLiiRc6kOJh7XAcFuU4BoWoSIBQQhHVx5yKsM8Q2PkinjC3Jq00wft7LrVg/SXbIKJQknQEuzrvU
uxHNzZWxD0pKzTaQKWepK8bIaSnPoa3XyGnVSzugQKma4dVfDFbC4KKOlj8H18UhHLADBchSbugk
T02ZWZpN9yi89dIUFjjZWZevad/85QSGdN56t/1QVz6rNdUvbqM6jiXq5KLAxyru5dbnCnft6ui1
YsjH9BMyuQOjzIu3diiB9W+YOlJf50kuUPQdLxWYPTa7O2BKYMoPwp/Mb74mrpv7ZjKLw0Z9wqXX
QxVPi8+g148rzwfwO759BS4BREfxloGj2PkrXl8BVJuszZbFtmYTtStZNMTZsBUIy4Y9oagOjRkJ
mx/ZtPnWC9FO89luShwgNv+dsviNeBByrW7muF5SRgIwQ9hau/S4kS3A/IuVTvdIeEbK0qOc2e0K
Gui2ujCowxjz37XhsTpALjtahh7PIa17McYLDNUttMczHZUT31Vj0vxqmGmpLKiu2gDkns/STfgh
5cnqhj+Gl+MIH7LwUtsjl27eGeji/cYdvDBQccN65Lufwg3PUqKqyNnzeqnnAcx+0WUHk0tYsq4z
+qXObiQQOBPslcsBbncm944tu0MZlO7LYnv1y1pkEBX8vryBKuydK4laZgvrHsWI4lu+TPLR+jVL
lnQrvFkQ2yaZ49Thw2U7yeKcUutnkfUci1l5QPe8zHzJdC7fzaDCmkmyBwFdTmhIkn+VNPBCiEmN
59ExylcnYEi2JttDMlFqP7b4zLqinn5p2JLP3ZTB9OQD/hUURFarmWsiJHEdVQs2gcqRFrxd6Ipb
gN+vnT37wEKAyXgEJwnbR7MJLPUTWGnzbHju9JUOrnsji9GnOpsAQYygkpFZ93+RGeyfWZmc5+zi
9p5Vcn8OYDdsRoWPgxABkRjH26VcORNT5c2XV1f2Xi16+mwVtwooJAzZS/BtgnyMVJ7aCTMEVpfA
HdHppVZP+eAXl04hm5p41rQ937ItNukpJczqV8Bmn8s7poVpHYzHIQ+ahzrwhicLRQtJFUnYNh2i
Pt6GHVOvHi75qqCYAao+eZDFb5PA5h7I/k3RarH4cS6s7T50mSXICyL4ZDBOOofTSg3gGgBdKQu5
r9Q/2MzbY2BMfkKceD3AHxyP80DPgMCm9VVby7LhwHbksePEiJ1Ncp46urqupJLxxJppJEuY9elA
/XhdI2ba2DzuuDhDtF+I4gCm4vTrzB9mH6Y0t759h8fxLA0mii3r2j20yMVMZGDp5zTAhAthLX80
CZqbBLwWPCR2GbAVdPOj0fnqkA7bBIHDX79GGiMSYvKcF+AAOf4Js7IumN7rfIWg5TQe64BbyIT5
4Giya3rVEx5ysYjtTvAFBQHhOQdosHCCBd/fxbSMe0oJ54S7l3Vcxin/06ebPLqmaqKt039m1/R4
qJviXwtuD+OjlolZLn2ymJWTuKhdexfPGZqTDfbSYcJtKAlIHHo6sKe6K7O4KZ1DvaI3loV10NC6
d6tNPnvOXDY/ZTrtN1v6GE0p0uim2fsc+wWt7nbYrqT6TrNtpOdAI4LvCj3+rgwn+O2sI+vEzuu7
E1DgMfYsl98H8IAs+9UoLIjY59o9e4j06JeEb1K6U/at6MoLqSDjWOVZuS8yZXC4Zu3eXvEnD1bw
b3IMOFA3AhhKD9CevAJkYgLRmbYB0RDgBv8TlYF1pzSeM9E5l3YtgmcNtgrUAjASEigYFpRrntKK
Jd7iWcETqx0+d4H3i9HCutIRYFw8iIJMKQgSkQ1tOSYq/MOK7uajoiI5KoQPckl2NHpUlQL9WIXl
qXaxcdeg07zwcmP4EI0u60+/NSAwdmlP6zkRnDzczItR9f2Hq2DNeCTP9orH6cFmBjqXUACi0cOa
UpdlduezkrouPPp8pKYFAwSxgLaiwWvuIAbm7h8WRPYjsfNvXH9oc5vODvPiTfGQ2d4h5P53ppnC
vATWKhO+v/2h3jj8yrENSXw2C+5lp0iKSoa/WMfR1XejJ9NxiaPUo8yClkgZFSOaCQ9gBLQMwaTB
VNmDDIHr1JR/UF8BIZEGuGNGrCKu48TPDHaFuuswXxpwK+FlO7dRzn8FDUBEAlhQFISAD0m35LdY
+pofcm9pGNhpey4945uPfOFAFeNgWsrNScrUz67YXTEEbuikhl3isDU7J7FE84H2le0HRMVonS2D
idMoLqh4+X410Nmnphf/tjx8G8m+vHm1wSuVQqJ+8pUWd6SLx4Qph9oPMm9E6W0/SqEZQ7LA2EcL
exCPG+6avNHuMbPwmGSgFEbgHj5L2Hs2kMGHmQGU5loyXyzB07F1Wx/n5QbMKyc22IrsGRTJcVt9
UirewMKu1Q0z2FqjgxFktIy2PlQN2WpGA8IC0hB7WYMFzn2xRJ1oxQmxFyxFXfQX4XMOReGtg8de
Vv/BEFiDJiQh+F+84FXnH0Q6TJeUEM+nWUtxhce9RYWJPhB6RXcMWWUc8dtCNjAZZ5LGAhWgi/Zd
tuzKOXDzkw090cfpvzI19/AsdzqY/HihtmZvt0Px4bQr5SDohhg30fLPgeHaH/ic3ETepop5nvvD
ZCFAI4U5l40g+bGEwpU0GjNtUcwANxYcxNppuveq8NtnwyV4y515xbiFAF7V/Wu4aivhlIAAxwbm
OFXCf6pzo0uwcvjvODshedQBGyncCaw8O5P8KosaXSto851SCf3C6KWafWkc3LZD3hbaGwjXCg9z
aw7YPGSI7hxMfBtwlNKf0AvjzakaaBV1Pr4ZjQaLxa7wHmA0P+Kpb55Au0PlcIBHyq2XceouPYBw
gQRfjfU1rfvttWMAu7p58bhCq4jLVv1wqHBHDikSJOe/HlLKTiCKMOW6eH52HoMiJRoozZDXECUW
Unn1fOrhA17TBtlmHBAl+WFy706H9X7u+htgTuXQjfF/pfXci9h3q39QPjueUrgEhEQH3EmYd8Fx
mE86W74IlfyWYC1Oy5av7xMyecw6dk7WjP9Y0U4hg0Du3bFQ6w4ynbmRkJKGpEBzTkYf0n+GLNLR
QNhCtIoImEy4qyp2ik3vdZEtvQGwMF+eUTfBdwXv8ToEBavDmTFWiC2/4y43cCnB8/bcB1VzCObQ
idMVWehmwyHoS4cGgLX6AavfEi0caQzKuH3mLtAAOdEwZVtgB+9S/6qtnrBsdd2GJylgnUD1F7/c
Xrl/CuvGzfLJBXnAVqJSF/LOTBc/8lS1Ju2WekkgwvGjXCQ6gs+1GN44rHg311fc5uY3Lz6B07L2
qaOpaOTgSnAHspFvKDcxYjqsoOs2bK54RxsGqo6hY+iN7/HmGu4GqDktBr9DDhz9UtUgNSxty+80
V/lfo4M9WVZpkZhDMe+y4Ya4BMPZ8RRV3WmykbHmXr0X+Ls+BLMaHlyCpv6MUrULU7qJyl7lb+yD
U6bxunpeKBl5ClMst4TTJ0hVC81i7uD98xzcNvyf8n3xbefoYoo4DQqdMqoQaXDB1zVW2KIeh+tQ
tQNSydCcOKS2N8vujbPF6v5QD4qThRnFpPGGEdLhUlj6ZO5S8QWf5kOK7EmBdYfuj65Uh2/98tb5
6Hkm4s3DoP3gQtko8+6EmQ6TK9gXG39glVXdXen5t9z41GIx3jpxshpFmwLy7MG2quLVugXBhG/m
VySy6qexWUELbGP3osNiOppK78NJ1xduF93jphsnMeg9S+Cx0FDgVe+FYQ9dJI9lR8MLZLgQZTZA
UKceJXYzaMnHJtjb2BydU97ckVqFQ6JSViL9ZJHsKJEeAgA/NyLK9F7MN6pGAM50XBq8JDg8Ef5x
8Wm72GDtj92e86PYT/RF8EdQd7FwU41XQ/U8CvaIw75Lt++0qx1++Tc7R1sM50xmJQZXAz67uK2H
ysB5crfN3q+AmOLQmcJDYPOb8kY4BCIF5QXW5x1FWXxRb+QevbJ7FoMcEhTe/zvmiGhDYN6ZOqTt
qNK/giXo70g35d98z/QdRhBsOgBAyYy6BKkUfQEgnVTziAy8fswdRwG7V2rRa/9tGPS4G33+I7OZ
ftubaQ1U33ChgzGNdcBZP1Yu3ju72YoDdL7ghmkjOmdbEAzqiaeF9+xSKn4WcOBBJpJBUVxDHNiF
t8IV1Kf+kmGl3xUekxW9L3sl031LbHaxgN0NE3TfEAkzmvxHIMXDW+eA4NnlWZ5dQl05Zzx8feyt
K0tPYa93QwnBPsXmfm+2yGPU+dWHTIU8NbMfYgRi9c4mkPqNNRyvA2LzI3uMIoLb/ofISrYHEp09
evlgHvUMNK5kd4ibyGrOqKpEbxurO8w2SLlUjdmDHrxvUPTt2exmcr32EsDYvy3TuazdUzbFtwUr
OccFd3RTd+mz5+GTzPweOmoLw7FiiYn6MbIw4qbzqH2iBYWJ4mAvgIemsg/ux1ny5Qyd22RG5KPU
okIs5Fe3CrJLVbWWR554Y09jZHEsAgxVXNisG9u5PSpex51sOauWKSzivCCE4k69fHbXgB4qvpN3
RkYTExZGgxQOdEyuqgUf0aD/k91m5nYY5p/AmtV346ksqSn/gigHgSU30vmAZtm+iHnNKIhxJnZa
QGbLEneOb4sVlRreYIq/5DL5xK1Tk1SbacEVcOgbLqxxukifmIAbOuu79AcLTTF1zjhxiIV75q8A
lERZIjJBOZxcmG1TDpw7Dw+uEN092K6CPBY2DprulphKL8VasEdAq7ERGwSpzZRsWVD3dCq0qYb1
BLlnCmtBS6LpnHvM+Ilnz+FpaLb+YJj4Z9RmjEfePuZoib4+lX4RZ1YTXGoMsTEDHUfSpD57zIRH
iWfmeQg2mlkV1YkAFMoECXo5gfbknfUlk/oqgrfUFM9+7S5x2a3OdfPdT2t2QcfXfFmnlr0EPsvg
WZGlu1YT37tu4vkYXIzZtaHyIwuVEl4DhT9r6JCEHXBgsV7lJUEoZdwybFi1rJru/vM0L5VN8Aa4
NrcZwthylSvnvewuZkhIwFZERXlDFeSHtj3C0RKYvlV5bF13+GJUZcDBgwoDpqoV56AjphNcLR5c
mEAGbiVurc0fxxkFjMB8OLqlUdzxXNkn6tq2I3cX9WDlAHXh97Z/mX4Ix/pT/4tqJELDs6H8ncmd
FKOiRcpkxP2Bkse93LdNDkxcRroaiSJVZGYMrOfPNi8X56DpxN5GYGV2RhJWRSo/xnGUT0LS8JgN
QXXIVm3GANbcGF/uF3t/NoHgNa8d3529N2UQ1nsJeIFwdoSlxz/WJQwBW4Wc+Kv1W2l/uEoW9+SL
2PpIE/tyjaN7N9NfFC/m8kV7mjgQtA+SoHHUD91F3tkMSxZGofgGzNckI4TV53AJv3I/wM82ohmw
M/uLrdfcs7DhalrUEvUIrlvQLzhBHEWh1uyh9onu4DpMaSYRcBg1bpr4K2FAhx6v2KH7++CHdHN1
2up443u7OSrDzh4td2qeHW6KmMYnjVaPKH3mofoeJlYTfdNxZQhyvkbpLPaLJTCSSlPsfN9oY01+
l4KSFighI1ykN/KYmAG7vcr4/AGynuh8AiBUhIU+aCO38NAhwaDfrBPFWZAPQ9efziX9FjG/Ci7f
uVj3Qd3+syhTjOE61X+mtV+eXF8ZX8OCNNRY9kT40HkeGC7v2anBnRKp/s3E9wuDmYfMShqG4lMd
jwqpaJkxKpRl95d/HK90p0l43MpFupIFVNDn8qxrx9nJcRifco6dY95DxqR6hqUEq1SrJb2OAYdC
FXYXFkm4yi3v3a3g9tCQnWV/3ke+pjRlZ6VresIIQOmT8lfMxHzYxAZ1RlHxgU8KM5P0x+0chjNg
4zyoPqYUrTqw2DPIik+DKxZ+hmhf0dQZBmrbOELFHyWunOUXzZOIyVXtwxURMPsJkGjdHdnMGFFV
kXycTZta9LrlqynIUIiF6qGtJTQZUvwUT/Nk0/0tCaaPK00IrBcvxE4eyqoK3jABlf8j7bx23Nay
df0qB/v6EGCaDBf7piRVlsqlcgX7hnBkzplPfz767N0tUQQJr254rQbaDU7NPOYYf9jkSW7egGyh
DoCgx4YEvwdtoOb+B14PV0YGZmxK5aOojJwyA/AaCgM6T4u6z9yd1Zi/XbtuXIqiXTc+8CWkqyBK
QZ4R27TtKRnmDgBl1G/RmQuMvr43gKe7BICBGwLYz8MCZ1nDIp6kIqq8AzZ6zx8xkSQTpSnpR4kO
eM/LSjRUVwW6i9KY4/PtMvzSou9+qxoSwuaIFgJXc8V9mbnkUMBo/DTarv7tGigV6kj6SlH2yyIV
ewPyJrvBDa4ff138G2qBvm006veeyu5GHwL1wFGsVOYA3vgWat2xh9yP/DlHLfMqLShKWpHebtl2
yCRQm77RiazwSiR0uyq5bqG7meFtgesTOqaImvkWdJXaVtEBDo3ikbrV8GZggvDC/xeXgsqTdnHt
Szu99noYfMCPACHKP6Ua8CUpuPxnaGg+j4RQ5VWaMzTaKHugN9ShDc3ink808WAaoPZKqCt3vEMb
WAVBeRfWJHWQjbd2KlU6pEI0c1engbhXldDHHLS71nIYyBkFUbTpm0ZS36haw4jUVeumNkzjXneI
KLkhoDMpmrvL4r7YoxQudsUQ5+hC4AVgFj5sNo65uNMQBBJ8xCkIJLN0lP0gJQ3ozPc3elGjWGMI
0Jsu4kSW0vg3AGYoG8Bwp7yjNV9KXa8/q8hyoaJKLuk514CU4WwsNkPmIK6ssfwKHwkXDCffLGrf
16bzZENfIKwb7UfkAWBrLgGaETw9H0kHojUMKQys51gcTWr9q0t48JEnKf1pIvmx9RLxyYtJv0qg
7I9ylsFN62wbYj1AViCQBRl4QRmXUjeMK2DeplCUB6OFKIkg+ZehHkGSKvqzsg+JnKdjvasq/4vO
TXgVNaQmSKSTd4XKguxnq6M/A0LNl6DqoV8HJkJGgm3UYZUkwo5AtqmuKrCNCN/svcBuBARMV7zx
+FVuGhjhcKAxRLnPFYWtEjQEwkrQ3arcWeBfpe5gksuWb7sc5DGGY6GZPacd5F0HDBVHEBkxVS2s
KyuK2G+ZxbTF0Gl8WyB2L5L4HRT5m1kZnDJNjK+xj6ewYYfFL8R5wTfx3i1RjTXC7RD3CInhSHxl
5/Bhe48DXOpQJ6v4oZsgl8RxAAYFCs8v3rGBUW+sLGpfQk8YXCQsu1KlbEq5bKByjICM5av6g6qC
Yee6VsCmaDX1U/JWuo4Ugl8m6c1QadaPNKjw2rQoBrgO+Khl9/pZS3bNsnRoprrJf/7r/5y6voN1
wz/ZR58YTTRkCY33v/280FTNVoVGqUeo8sTBvNZdnTd2nz5Dfv7sDtkmVfqvy01cmqTThLAJzzXV
ELo8MWInq2ZSim7SZ2V47K03mHFGCDMZwuNyO+NInFuk0wnFtFWGSpNxtz4fKR+LCtHHdvKcBU9k
KvTM3QrO5dr/kkMsXG5r/M1LbVnnbRVQmfzRIPG5774k7m8bfVibErdCjj2KQZc9gANbbnFuFC3N
VBTV1viXNq6TH9+OPi+c//4v5f/qNbdXDnjqGcAuPLMqPRAQA6lYbmX83ZN+6bJpGho72QarrJ23
UiuUeIUvJc+6di+40ZGn+ejt20i9zdufy00p47eW2pr0yMWWkwVPW2mLzgJw/3p4hj8LYvEXmOBN
LZFapqDR/rTtly4kpVqudPZya7EaLdPWbFlVOA3HIT8ZUtytYhukIFvr3iSUTG6XOzgzY2efn6xH
m7JxofXh6Ib1iD24HNxI7n1mfFpuRcyN4kknJivRsi3FslpayeN719sO+l2tf1tuYqYjXBYsPl1X
NOprkw0cdeTUQCkkz9+j9GsDJzGxCZS2y40o6mVH4HGpJOoUcLmoo57PRkD2VS9hmj2H38yrXzxj
fPOTFd3z7q6le70+gKfw7LflRmeOjNM2hXzeJhgOLUZmKXk20XUHsBpm9s4luxOlL479sNzWzESd
tTU5aQPHVgcNy5Vni3RoC4lTRylF6T+WW5ntESUSHaSXbmOXcN6jBLu+ENhl8qzab6N0W7uVmtE5
F5DI8H25KXW2R+weQ7A2bM7287bAIputXNEjol3cUp4R37s2fgtMRTafc/2z0JxdU7964g7rN2ql
JP11qF5Pdrrnovcdcg9PEUJ23R0Okcs/7WJnm6psyiO8W1PE+Of8l3VRXkmSZ6tH0ZQfhfqqJcbv
/6yFyeFV/asFLX1O7E//4dcnI0ti1YYMzu8vFFBA4VYi9lv+/QYjcHb4TkZo/PuTs69wDNLLMi2Y
lAdS3L+uIvEQru3p2VbAlanGeLwS9Z+30igQg/A9045kQ8AjoVKjOugPNRomY+0PSQXi55bPahd9
VSjpdSJ/GQGdbhDdGBaP8Sbmkccj7Wa575erw4BUCQnF4qKzVXtyMIep0ymyjAN9bb8bxmtw/599
ftJpHdHFsKVw81KgcBpf1397a5kM5nhdabJKWKVOzpE89DMgOIJ863BbdzdBt7IyZkaH71vgaWxT
ZlNPRgerR3y0JcU5kvlOUGX/Bz9fNQyTCwVRfd0ar4GThQdaVMlMuTSPRbkv0B1eOWXnfr2u6DrM
PFUmDJzsnFDXUD7pOweBy/v+uuj+fm5VMUYMQjd0Tr7JJaVkqcgCKXJfDDT2VDbOX298oCGWaoEl
0ji8tMn3NU8HLCaZ0tFHiA8p+Fza//XiPG1An9x4ENWVPsEoGf038hw3SboSpo7je36uGGSwUa4Y
DVsNWZmsHvBuMDOq1H2xIf/h6UZmT/yDBQokyJCJFTjhrXEJnKygTM4CrBAAvJTuT3uvQlZfHqLL
QwuNE81gbRJuq/L0SSSkqpJ6KlwvnEA4uAKi0/DyUf9+oZ61MtkHitQXVaFp/ouPqBIKXslKL2Y2
wtn3J1cgsvQQEDB3fqmKu8q/I1G7PEpr35/MAr+c0NbX/Zf+zURFMF85o2cmgevCtiCk6TZh9OQQ
9QUGS0OnRS9psgUOHj3wwpL8zXIfxsU4WaxcAFS0DF2laDcNOcu8iKjL04hc451ORSN5BAxVuNeA
MZdbmtkW7AidnWHKCjjpybEU+xg+gPwqX2LrwDsRwIJuPy03MR4Nk86cNTGO6Mm2yFMv4FTPy5cQ
lOl1l1Cbs5BdwARtkD/ZYf1SlgJ5UmSYyAzHpJiXm5/0kPKrooA8pY+yOSYrJidXhzUj3jh1fagV
9S3K5M+ZGfzSSud6uZnJsps2o03OL7j5A8Wjtj60sflb7ov3Mau43MRk6f3/JlRCZ/5RVW7B84EM
FUj8gcjrgzt8Jb2DcKG9bXrqjLiR/4OWeGfLNvQFHbff85bc0sK41srqQ6j1DyaFjk0jcEAqRvX/
rnxcbuzP0XuyQP70i4vXQMpHtjmcJ2vQgSCaUyIvD1napte0hJ8VIKRnxGXMB7tF5bQ25I0ePsWj
CkthJe59YIjsTtWL8KWPi27nqXhxZBkcP7Q+sO9pmupu+UdOduTFb5wsYn1IlShpmvJQUM0MPWiI
UZvcD8BRocq/93G2W25vbq5BMNpctRoJtul9LpARakTRlwcXotaV6kq3at7sutZA2sxYme1pwuNP
53iV6MoYvo0MxfPpLmqRyHmalQdF/TW0v3zpw9Rem/6Tgo5yguTyvRzi+UC2vsh/dtrKxTw3sqeN
T87rAjyj7dV5eSjRaNpoavstN9vXLgQgA2PsVmucX8tDO33Q/093ecmbsi0s2Zqs7i4crKjQyvIQ
yfAtqOYot9D+xDYCmgyVsw4esggkKBhGyiYFlWO7cIF+gXtBqwj07vLPGVf3dPWbiiAykXVyndPA
pMqBXDXIMhwgukMvzKQn3Ip/dV6xcqfMrajTdiYXV+fLxHaQTg5JvqcCjREIBPYI+S/kBZZ7NM7Y
ZY9sRQjCLCKhsccnB75FTZSse1EdauyuvgPLQIcAoNrP5VZmxw3rGtWwDZIK0+eG0ZS4M8BMwGEh
/9Qn/a2JEbVfeiu312wzusFFzEqRL64PjuHSclqXzhhgO8z+pbBNGEMowix3Z3Z6BFks3RTCsKaH
ICoMrWn3dXXIbQ9MQJo+SJQzoKj2V3JhrgTbkyv5zw6wVGHwjkKQEQrC+Qxh7Ya8WBdUBzNGOlpI
+6JNPiFJG28oT8OoNdVrObF+qmjgLvdSGa/B6dqwyLrrKskP8u6T2zhUHFH1iL8ddPtFlm7BDbLF
EEjGkQ65SU96L1qw02u5yHFtX7TKhamOTy/lIlFYh3lkupZcHmIFy2i9AvyXFbB7JOGSXrBvUjP2
QNx7L8u9ndsIljAYX16s5kVwBRh9aKWcZkcbey80XlTF/L7chDK3PhHdllXSarpBKeZ8KjHz1bxI
1RjQoRl2NsgvbHwFUWMlobhjgHJwsd/ZuFoWfW6SKAbgZg7k3goATiNYPae2eYV2WHUf13K9Mt0z
i5pg2eJFSoQpLhIaiqd3VQ+u/ZCgzgqA5UpD6169b8T78ijMDDTxMjQ9IIyarE9fRqXoc8dvaKeR
37v4l4Ka6HIDc+v2rAX1fJh74KpBG8Xlwe6uMxyyzRSzOx+RvfKlQEe7ad9MC0dPUDbLDc/cjmft
auftxqgrxLFBu2X2lqPeZJVbw7ktw2PgvP19SzrbwzI1zp/LiMNJErsc72ERfktHlY9Dk/wq24M8
HJcbmpusk4bMSaSMOh3V4b4mlFIf8ZX9yxTreLbxTP5XP8zJ7W5D1wl0h36gZcRjBsl6O/0nq+G0
jclq8MssxsFvjFmyQ0/oOVq3tkgPxdUbHM4tKwW/qOC6N1eGbmazcxGNCR4uVgoS49+f3Kw4skq1
sLzyoIEsAJoAADDH6+/R1RCHW56luaYE99F4RQiu2MkwAokHh61wdtmYqJiefus5j8Va7XCtkck4
JnFL2s1tywNv6is3fi/Nb6gkrszW3BY67clkCxlmaWMsQejuWXcu4HTZuNXVV6F91u3t8pittTQ5
i/MeyAOF+/IwoHWKWaW0KcXGLfdBtRKUzG2h0y5N1gEaUBKov4H7zOkfZJAYZqh9X+7L3NF92sT4
9ydLrYsQadQkRs2wso2bfPc1ZaMWN2G/8vqb7QqF3fFqVmlwHNOTdtQqN708YiuFQS/uXQNcUScN
6W65N3Mzg7aTqVqGJgi0J6s5DgnYDH98TkWxfWygC2+KEBigxDmyrfwkv6+aoXhfbnRuCE8bnaxu
rw08PFfZQrCwg/a3p31GMkJKXpdbmekaDFOTaErl/r8oT8Lvs1zLRcwU9+7hWR3yDu9MCHHozZEe
sPrqObBrsXI6zL2hTMJufA4tYTOmk03VoJua9grLY5CejfIbOjQPBXobdQy7EvHm3Gi2wkOCMNgj
Dw99a+U5PnNwWJqlCJk0K5fVdNWkNf7L0NyLQ4l1MhxUhA3eVG2lkZmRpRH+cJvoQjcnfSzBEedx
HhcHT7Hvffyv46xAmkq+aqL70b1xeR6VcQ1OglRLlwn+ZUoovJsmzekImGOKMpKd4uAZZWEg2UFx
03jhN1FCBcRT0L9yG/01hiU5GhF0cR5cL/+Gmc04psh0jTOfx+A07wjTwgEjbOeHLAq+2vkXHzPP
lW7OhOKnTUwr27yf3dQAen4IldvMqvYBuKcgf1EHeG5GddT1lUmcWym69WcKqasp0ytTAxGvubqe
H5AqRxSse21Idkod4dvy0M1sdvYe3ycMp/A8nb26E2oxgPg8KAFsym4f15/r6tnwvyw3MzdDJP8I
c1VFp8gwOZYbG6Cm6Rb5wXkGoG9FKw/DuV6QghjDP4Nq1XTJ4/3ZMhNIDQGvbPMHjLJLE7Djymk8
MydghcYSHvLLBhTn8zNfS+xM7mOUzOII/KmE8Fpd3YD9XWlmZqnxKKJkpRLRsoEnzUSJCbcqwh8L
AtcvSK5fnMr+WdXWY4wR5GjUi+8Xf7VyNF62SmlmLCzzyoUONH2L+GYFbzLrZbDPeOoNOBVtcxix
hotZjIqeeO+0INz7teTw5cIYmzVkCq9jjW4aVUfd0CL/GcmHTNnqr41ys7LuLufs/PuTG5SHJfd3
xvfjHk0mQwKR13sOTkRddHCBvoexjgxT9UP10w9eNN+KYrjOJHKIo5m1NDrPgja97noLtyQsTTz1
udR0aEDaLQKez1ljs1fUch8NOYIRWv0qt9nnDiNKxA1vUmC/UKBewiTDMxPXGdvtoLFDT1JRuKmN
tyJFqm6U0IjT6i0pjNvR3syQtI1SKQ9h09xwc64UXNXLTAagREquEM0NTsqLHEpiWAEqVAx45oVP
Q2jV95giqfukU5pbF4u8o+/o0AwLaARPVJJ+SFJVvPTuKCduoFVg7IevrVcj4SP5Vri3HSMZQaY/
iqwYqUN1v7IbLhfIn59JpCBMSzOmWU9Jr1NTj2Jj31sfhfWxCpMy5hrgWOLw4wVOIDdepyeRnJmj
MI8TObQhy0Dk1rd2Iug/yhopN6XdDRLMKWAX2xwGqJEAyNHje1Fo/rbKkzsSX98NiBNbUTjPkmnd
Ya10myTFHZ/apnIPEjwFRQ4uuugxJazs4TWxwnoLDQW1Qct9wpw2vLf9QVwB3vul4n3rpqp5NUDw
wiXzMY5QvksL96FLiz2kUQoaiDCjpr1TA1yZtB7gO9juTeIEJXQIf7TkSQyU9tqbLrPek6AKNr7R
HbwugUCulDtJiR7UMfBAxRRmnQeeHUJRCWKoxzYcQDgibFG7Qx9n9KEPt6op/bayYNMhZm358GIH
NE4rKb8yG7DGOPVBK+v9Ck1b1A0QEY2+dFhro0rw7gt72ybIomb5k8B0TATBVtO8Y1V5dx1manpl
Pzhw5/2gvNcM7d20xZ2nG3BW9G0eYf9VDlvMqa5BnuyBKkLKzD+bDkpIwn0cvOg6JW06VKhDKtu2
FDu0Xfeeb3EmI6gLufpT4va3SMR9VgznGHlNc9va0CvDwXh0C5iPft5+0xP5PdXQOZUk3F7VXd5C
bq2iAzp6HobEKEk3VrdTPVaBpe48X3x3lOFedpG6SLBLQ08AA9+uxx8EpgL6e5J/GLSAZHgbHP0O
0m+lf5cSgfxsCOudvCWCHG3yVXNNNDjBhuOhhXU4BgAZOnd4+YV1pN/gT3Cn47SzLQeZsUa0Ba0w
51sAHBcHHUgDZg45RzfbrQWkArM9Qir0vr52VWxdG45YKatbl+eFocgkw2XeOqZJ3vh8e/hplDkW
2B9MME1Y/tFQ3KgWMkxlvlM8ONi+jakoCpKDDJXWVnwVIayhgjUh/VDLfpeB8cYiPd65NWrUDab3
pm2M58pdI4VHyUg+MAgBvJbgFYbUBwvU9R6DKhw2fVehLlZiaxwO+WuHYPqdIcEvcaQvcp49I/6E
AleLV672LPXJp97VH/22Dfed2qDSnPVHw07Ay+k3KvsHD68PyDVfISu9RyhRoUmVKRulQELUsLtv
SdB8FUr1qMrZHjvALUI0ezPK7tx2gOCCFI6F7G5f+V9JtnMLCPHoU7aDA49We6Sqj5WHdWSJgHIv
OAryjd5ocEKQSfFQlq9QG/ca5cHR1Vs/GF6USMPrOrBRFjZflq+7y9CfyRLGiNbWqC1MS60405ER
x81vLypY8Zk50j7q/oiQ2jFFMcsxjJXwcebwVID8qqBQABZQeD1fHXGSKm0ZNmKvS/ZXfK/fvWbl
/P+TWj9/X9CnfzfxJ8V5cj7zyI0q9IbEXrZL+cAgutcpCZj3XkpxejFDm2tLaHiEXjuU3vrtU1Oo
d7IfyHgV/0ZRBCv0bQ33wul+5Tkqb77Yp3WZ3mdajiy6XHRISSGn2je7NMZFuIib4S0MlPIxxL5m
JRy5DLJ4/AE3I+Nrc6Cp6vlwYdCQxk04KHt7SKIEAUnLue+TrnppQzsHNOg7Df9jX+2Tsk//+pFk
KYZMiUa1xpt0CpmQIYSGwk7VfUh4+YnSEfBS9CVWAn1j7ML5dHHuGCDGSFig5j6Fu1loI8PudNq9
l1r2Y64V+asZV/FdXeU42ZAtuWnqxnulhIwqVCsZ3yMTj2LFq9XnxJW1ex9Tk3shldZblMrisfAr
9LVJT+lXwoTRW3Y5ooAGUm8vfRLhgeeK72mhui91n2Iyrmal+wn7uObIixUfR+i4HgJlmvymZpr8
A6pNxuasuFo4nD4paCjuYMIbXxxZVNc2bkDoCKq8gnopIW2Ut48mguaPeolAS44L5l7CVWNLyrS6
7ZUc6fMaeSMjVxCNKaHEdnjJfCobp//sOEb72iQZy4y47peiluV1xXGx8YVwnCsUM6R4Y4+K1oHT
FDsQlBoGd8laDvHyXUS1WGMmyB3xdJmWNIlMrcaq+34fQ7Orn5r4LtAe9GqlFH55CNAKF4Rp2eNF
8QfXfLJDc7PJM9dK+n2QP/fJk7pyxlyG8JbOklVtXZGBzGuTBEPb+GGVywqzYqPzk4c6er21+y4b
ebfS0txwUZSCck51ncLp5LGgBWpsdq7W4QfzYqnIMFx15kO7Vkxca2VyCJAOU7J2XGUmor1SGd5E
2pdqTPCK1+XbYHbgTrozGTgp98I+lWlITn8TLibpgyy//2dNjEvjZOo71epECMF1j2m02+3hTkvt
ytv+8k5j+sfHCplWSmXTnFkV6o5SxeNwlWz8cIvAaF5tSiAP/srpPDMxMJ4gbY0ELtWwJpdZpnQ1
jlpKsw+F2fz0Y9woQnyqnvwAlVqFOt7fF88tGiS3y8NmvLjHrp+MXpSmBe6iRrN3AfCX+PnpdCsB
QuGgPbI8UTOjKHhjj39kCyD/2PeTpmQx4MbGTbNvSqwOUaQcbpIsy3/Gnt29aJUcQHJuUaNcbnXm
ZKCOPOZlQLPBJZt0UHO6sM6lqNkLvcixiZTl68bspZV5m1nnwuBlaP2pzKvTJ6LQihop1qzZK23R
f8qR6+Tl7iq7HiXD7XKH/gCYJtcbtSVS8mMOGfHDyRoJZcW1rD5s9t7QBIcG+dQrxQilp9rIy09Q
y7UfYV8Ne9MU7qEYBukbDjj+rY7YPLi3OPmCqo1/73Cf7TLHw/y4AgwnRXVwtBubx1eqOKQMEH/T
kmG4wlgO9UUXsYddZJsWElWoOqGEYF/XeYr0Ft6A2xaNMfRuRntHlBug3rqYeXbljwrmMMKUMDqN
Gt/dvkMvXO54WzQZhvMaav4aNxhWIB3uKhGKy1bocz/DKgF4uMkC4V7rnSBLjdjRna9VnLyDh0oo
rM+7OoGxawR69K7G2i+lq8Qvuxsg0WfVqLir1DCPW2fne1V+EyR5+CQnNciTmqz4r8FxpX1kVeh4
agrMaKRqyva5Chy48ctzdbEswE4CBiSJChwQeNjkbAIokkWeKP2nUBUbaNUbRXx4w8rau1jhk0bG
H3G6r/SuxaK38Z+StkTL5N4uVwKqmV6YMol1weEHv3z6/nI96hV6Sy9gGG9seLex/hand8tDNdML
GjGhiXHSXoK5oBAjtCNZ/pMSfXGMt7UawcXhQ0pWJj0/ljwMgJKTY6CzZTlnEUMjlQmaJHKQD4mr
N9/szDDQYjNZ/VbrrGzV2YFTgS/ovE0uo5I2ttyhVRz/CZOOjWoh92jf4RG9ssgu7oyxa8BERvwn
GehpvdkQuZR17sD8ayif6s9J9xaUcPWVlRm6eDngPksrIyCFfy6idz32sIkQZvhU/anQW518XWWO
vZVb/dXCjQapTxvhkiATKwv8Yhi5LjhYbXL2qm5e5N+y2EX8BbHzvV7Jzr5N0/IrypfFo1Kl/Upu
cjw7p2crJDsA5NwY5L0ny2QoHJg4TdjuS6lOrgcG/Cl0GucplzAk1kxJ2zm4hT+aauT84m3mrUzl
XE+R41fgVIMlYameb+UQ2TtoDEW7R8TrR1GjI2cExRtylt7KrXixHWSCTKHJCnEmqIjpKx1lQk8T
OQEtUm1o9lju1mqe++CpSa6Xt/XF4pw0NC6qk8PJx8fCrHG/2BtGtim7Q+mDQ85eLNfbLTc0M3Rn
PRpn9qShVB1lXrSBEH24TaVfQMi9v8dcnA4awk3nTdSibSRfoy9IPQ7BZ7yB87V3zHIvQIGeN5El
eMBk43CF8W5oblLpq7xWqJpZ4qTRKDwz99jxTlGzYYA6BFdWs9fKCiKlt8uRO7FyjOTIpcXIaQ4t
RDFU4pbn5+L0YCFQXhnPKkXngTH2/GR+rNLkcFf9dp9W5b7GZtl/9aq7Uf6qQmwmFd+Wm5tbdzrX
yEiapRI97aWRdqhdRFqzb4dnyutXlYkX+bsi/VxuZq5XPG3hm1i6yv01WXU9xDGrM51mb6Bz56BV
M0qdf5hd+EMOddRfbVySa91Z2b1znbMoNaO/QCCtTN8jXtRqthQ0w77yQE+5T4P46iqI1yL+udy9
i4YILUgRmRxI1AHJ5p1Pml2lnOtYET/p9qOevDpIcwPVMr/8fSsGjB1Q+4rNKE6WhuL0sRkaOBg2
zUcXogGIbaljmQAs19hBc/0BBobwLUA37uVJf4Iw06lmciEHQrvnDLzRER6po/Q+Mqzb5U7NxDOG
BTucRcE65L/Ph65uxNAauRE89fGDeZ0NK0/Si4NiDPrAOpMogOV0kfXs1QzGD/D/p0JKrnMz/NxT
PTDKYQUu9af4fnYh/gkuNZ2oD37nBW6OuIn8d1f4T7YWb7UMGzvKPS9+uHfqo2/cBNVLlnRXlE9R
zD+m6lo65OKemsS2kwvRqtIQPaSK0LNF/EnLX7JO+lrL5TbAanMIgpVT40/286S7UHAhVMmGztvq
zwk5mbVEc1CeUqrkCBEft70Kv3clMbBETSP12pOoNGQmLoKRsPQHiP/Igkcd4jiGHQU/C08uXkyv
+6KxoH8Pvc+2UYP2MzZXiBQ2rvWUY0J8XQa4uMgI7ahXXaGZa4HuZGGMPbDH57WATMzamIYQrYTf
Cpmw6NjU7Z0e9ch8RD45ZUf7WF7gcw2h/iPgVaMhQVbkfIEjfxybNtZixzJLmk9DksgPyJj1z4OS
DdfLTU227Z8+wVfQgIkQv19g0BBfjfw4k5Jj2N3W4Z2bPTY+fqMrsd9kx/5PKybgflsxKMJO5h5X
ocyFgpYcM/9Rsa7RaVvuxdyAqbCk//f7411ycgPmiF4ZVsr3yVGqNsqfByt8Xm5irQuT803L0UbV
Rk1qWbnpn4xiu/z5yW5khFTZ0khGy9w7EIDGeTrpgR3XqlcZWnf0cRTWv5AEkFV0Pr8PP5fbuewG
7cBoI7ehUXhVJ0urGnzsWoIOT7vg1t/h4v3Xn1fGXBcCVxyfYJvOu1GqVNhLvRyOiLZ5qKf9/a9X
iThsgmvALOCNzz/fNQIFRtdujmXkXmnvCfYzf/37aUDwRuEpy6NcPW8gaBpuBBG1x7b8qZo/196T
M6PPHDM0nPoEiNPPF/2gx7nUt0e8xTbhDXfCZvn3X26EERUI4ovgDNXdKSO+NUPXbMy8O4pQXLnF
0ZJfHDQBlxuZ6QVSQ0LBwNXkaWxPgvWokdF8zn1xrKz7gvOv+rr8/csziUK0bCvkM8dgYloSGOrI
iyQRG0fxWMpvqI7tQjvF2Pl9uZkpfWLcc1y9OruBIeNIn7wIBkd38CPxzWPhHZUfVnwj6dfF76b/
Garfb9105b6fGzWbKgqYL9iTNHq+tNrE61yvp7VRINA8psk/mBY6o1OW+3PJKpMGBte2UrlLsAvD
9GNvk/5bHq+ZDvB9kGuwsxAOsyabrxGqV3heVR1NchHqbiTwLDcwHg7nEQJMobGuTaZQIWKdbL4u
lU0fRlR1NBB5zvGW8Z+QrLVepbcsHHbLbc125qStyTmYxAjeoO5dHaWRQOpvpHxNumNmFZPmoLiN
usOIg56sLpQ9daMvh+oo5ENdarcWMm6diUdMUV//fV+o/WqkNgBfcsOer6yuiGJVQX/1mH6rjBvX
vPkHnx8TU4icESTIk2lx8SiX3CCsjwo5MIR0yxUQytxUUCD51/cnU5Eq3iBqJ6iPOM8CAYnMlQLm
3LIyeQIhrU31EjmS8+HBwg5x5CZsjoH+K+2/lN7PrPgeyV/j7rdQ8pVNosy2Jph5Umroz01fXKKR
Wgwl9PpodzZOSDs5uC2fexk9XfndiDZ2dJcA1P6e4z/Y42ewDeKXYtg3G+GvZbym2O3xfOOY/vdP
mayLNLVt6MJafexNLH6lQyN97f2vgXQIsX9PrkR1HLwn1f+8vFxmriA2MLomeHgQVpqTEABOn1aQ
vuMY+ii/duZV5f6DY4InOrKRLBoC8Um3ukzGeD4YzyETppF/W9jFHTyJjarfxnhvptaXf9ChERU8
IvtJXk6uOxnn5qhU7PLoCMGb0NkCpH1tcKpZbmZuG/C8AGOvKBTypnnDtqOWAriqOKL8KyFEHqyc
eOPxPD1dxxIhWoV/MhuT60EfZEmXXKc4ysVj6Rnbtv8E6tjInjBSXDmQ5pbAmOoFjMKT6YK6n2S6
U+NsWR57L9d2g56qV16PbOEoUL4yauNkT3pljdlWwikFOuv0qSQckRp+19bHVotCUihdCXDtPXVa
jWKWm34sz9HMGIKGA1NMLWWGomy0WWDGRlwfpXwfev6otWeptx6OY3//YmLsWA48llSb63Cyi7zA
9HT8bepj5+6iCp9DrCqW+zKz3oAr8S4ik8LLY4rrQN7cj73erI5O6nAxbb1iLZgeV9R0bkDesg5Y
0NAdJjegHSAWnkpJe6zc+LqPwisz6A5yE9w2vf0UmukeV9j8SnblleU31zMK7yNPEDL5Rc8ipczd
BhjjMTS72y+S0d3+/cjxUrMpJKggCab5J6XtCqQ3uuYY/pa8a7lcWdIzu4eXOKkn3lCQKuRJnKXC
Yhq6amiOyKZemfVHi6C12yt/P/3jE0pjiCC4XcB6CjTmGi1Ti6P/pnwfvv3tCEG+GgkOjI4gaJzM
PPUf28oS2z82TfhATPeA1/zKrX45SudNTKKSOkUBoeS8P1Z4YQ0pDg+SCfDOXmECThH1XKK0w2OH
Tc9z+YJyWued3mtR6R8j/BNue73DBdDB/9Mc6oNpp3e68uHm5bZUUVEvDPcRL9j+m+sHyXcrK7Jr
OxxNnlpFvykMHdCmwEAvTRN9WyeWi7+Y7q0s/vFgON90Goo1nPMyx+KldpKLZ7PeD65/9IP4xkWN
3lJukqG/A+x8ZxC1S2v1rinZ/88IUYXV0C1hsTLj/KKT1EXd5JHdVVpwxNlI2egw91P18WpbjU5c
ctbuzMht8TKztW1gGf1V6mo/ilzvCEHCZtdW/hq/fybuYQh4QSgAFNlAU5maoQRPhlNEcAyC1x7J
fU/e5eFDig8huEVMQyNF3lXFd9tYA+RdXg+aID3IK48UxUhsOB8Jb1DbgYRxeAQGeDVk3XuYSHgm
tFZxFVbac6KV2+V9NhNtjpk7cnfwG2aiTcgvWRwkSnC0QuTjyocBlKRn3zae2Orde21d69LeLTE9
UcnDY/KjfGDwvDHE6HJEqU2NVy7Iy6MXb3oCP5Xnoa1wupyPQBibujw4TQj3F7HKW9zAljs8s+vP
vj+5FvMkoN6PIv6xyp/DMrlCG+AqXEUKrvViMo8jkjZ0yzY8ur7YZfk3BejNf9SPC2HBuDdQ8EUx
ATeHAhtM9casVtbGbCcsExqqRcbpIrML0NFU4qIPj83PwAK7v/Jqm52Jk89Pzt+SWNmOBsaIJy20
0xapq7US2ZTPO54sJEPRRiQKIm1ykTIRGE9iFR4e/f6+tbHwFNdx88i/Tf02icNtiD9Y/awPH52z
Fo3PbGUUQkjEco/NyH8lQu0E5kfhUbUf0VDwB7xDiPTkJ8d2V07s2abGK3h8zZCKn5yfutpQy9Bz
Jmp0SN5iP+s4t7g+A3lbXnRzK8I4aWiMpU8PalXkiZ7RkK48YwNW3v2TzwOUhGOIOtiU7Ne1RZOr
FQ507P06vG5XFtzsMBmUg0FvzlRmi7ZCgEIU0Eq0TSRupIP2DfevxPjr6AtcPD+edxgZ2ovqn+Hr
OXB0Lo++25r2VuW6bv7JhP+7iSnnAXPhWG0MIzjiXstsp+qzBTjPwQl6LQIfZ3QSDJx25s9NeTLj
wf8j7cqa5NSZ5S8iAsT+CvQyi8dNj7fjF8IrIMQq9l9/U3Pifu5WExDtE36cMNWSSiWpKisTmjZD
Yrn07GqQmtgzCDtCVa3buIot+tXFeKRQ0FS8doreoWf0OkJ9t9yquy2OAq88vIdcUWGWwnGmOmgH
spLsHImuPQiEe0X+YJbndfddCmgWsFDIEgEHBRjW9e4AeK4EV6uJVaEjGmM/2eNDM/zFFgHQHVwp
SAw5MHVtA3ejTp/MqjjbKH6m+/5enmoRMC+/L42haMBxNWu8OM/uRxNSHilyjvE4eULbdH225Oq1
iM0QAkByCWk1DWAQyRS4ZqLUduLyDLo2YCMH4x+WOB8dB5I7VfGh7sqjVSpepidAIrdeW0OkSac7
bkf3BzX0JRDc9pA8BgJG+h0pMyA9Q1GXI9GusfcOvT8eAN6ERzhyWoJ3Rvp+lo1dXUPZ+ExY9VJF
0Y/MbR/yMb1/DwnaP0AAAU/HxV2/9gyo4alJQznMJD++mfT7+mot7NCrr4u/X8SBdEbj8xg1+Tkh
p8w+W7v/9nnJrfUxRRcxsn7Q7fzs7iz2cf3z4r9LUQxJJACNdNwoBdT8+tcPqT3HU8vp2QS9VfFB
MT9Un9YtLM3PpQVpAHPlJITXwoIBGfTd8Hn988JH1gYg+xCIhdO2bhCG6yMfdy0wTSYNmnKrX2/h
7ecC3Ih/okRzgxtoAD83Ib1Iz1b7TMfkoYAoyKA/Axx20PIzQGQbQWDRngF0PlKKaO6XEyG8N40K
gqf0XEMlzpiMRzv7TMYTpMAjEKEOWy/NpVXCTofsBSiOkSSV9gidstyESB09N3QfeaiPr6/Skpuh
aIrWNoEjuDkAYk3tc4DucfLnVVA4T7wIZ/K6bmPJE3CAiXeyuFzIKTHOK6NJStiobIiJQlAq6j8o
FmSVMyVYt3Q7GhSaDRQ2cfcX7VuSz0Ek0cUzBscZydDTW3zsiBYk8e91I7crcm1E3Nku4spkQa13
nHCTsazRZ/oHA8LH6xa2hiE9+KIxUgCSggXWD940vHdd3yrvpBXDWXY9DOmCYXFeWEWMO5/eQEDw
YUYrVfU3ywFEgYqEGIiS5YXXpnjmZY3lsJX9PGveAI5Jl3xZn6zF5bgwQq6XY4zdCklyGBkoZNd/
NtFGMmxxMdBjipSqwPvL+Y2ZGmatjpgnhWR+Aw0ip0T1tN267y0kcLAef+zIdDx4p3REnXFtbb/Q
zjOyoKgPY7t39lDs5p/TFNTDG262gAW4NillLE3Szyk0HtHaD/ZdoebO6oc+f1YoOt/sQ6nt2VAi
iXN3OLi2Ki2YPg5zO4yw2tdB1AUV+GKZZ9xfH0a22rTQIoA7NID38i5tWjuGJiWmcwCjQfSiJT/u
9zs0loBkA1U5kDRJgVkxmrJLUoXhaZZ4WnSKko3ds+TYSFPjkEF5GzAvaXXmaHAdg9b5WakeI1cJ
nKI7rA9BzMH1EQ3UqoVLEsQ8EDDlav1oT2Q2E4udOwjyGMx36DPYR2dIjkMued3UwmBETtwRKVNc
oGX4TJ4PrLCqIT7HWrnTkyd7tjYGs2VBmi43nifWKrBQvjT6rrL3dw8AxS+8lQQbF4BMIkxcRH2F
1nSqejU5F/yh9Kvs7kcSajfoEgIIFz51g4stjBnKiQmDqvLwje2V9vv6r18IYleflw7GqNUhG1vh
8+iIi7C9KVSjra0ajvjItTtBHxCpEBePSXQpGdKWQ2K+jxzel6+qEZRFBRrhJDDpsSV3Pxuu7UjH
ozFCixoszeWr3bwOFQ7In+uTdetJSIAJGj/cKQHFkovSrpUzIBMz6GL8sKwngFnWP78wTdgKgCth
M7wJIVx7UkftQe3BJQM0ovOPBUYdelKS5oC64D/rhm4XHWljvLehEiPw1vLzKq4zZ0rzLjpz5VR0
+3jeW1sPxYWpAsMa3opADSLeyjUvUuruWAEp8woaqOp7Wd8NoQUk/eLz0lFhFEaNRhx8Xqk/O9+r
LfLO2/iHohxwaYAGAL2JYvr1SkCnuCAN4ezVpR91/TXJv7js1UqD6P7ggZZNvKQFShR7w5DGYVJu
2oPZ5q+VknumpXi2vVtf64WFQFMAnos4MFAHMqUN3ht6anWGU7y+L5kCBp8t/MnW96W9Xbm9ARni
qHg15p0xHIvhbqAgsiQXv1/a09ws0UUkfj8Zj9m4dzamZ2ErAACCYwfSgS5oMqXLbq3VKk7Skr1S
51utNJ5JgcFPt8Q6Fibp0oqcDObFWDTgNWeviuuVP6zPdy/x1dclb80M7pS5VbDXzgnmcce3+BkX
f70t9psAMt10tvf1gPV1U/YKPeCaBtMcrP/+xTW4+L60xLoWtRkzE/ZqG7umx4PAz7cKGFsmpGUe
ZwWlVUAwXomxd8H86xy0O1t+8GyC5NCfUcjAKNqzsbSB1X3NHDAqTNTQz0Y9Tb7Jq2iHK9Z8XJ81
MSvSoeqC+RRpfpjGRVC6Zo6GqSgzc7NXcxw9pB2CeDyU5i9uZl6hf2nmylu3d+sFKKKjJAPYII6O
G+BghjYgGuGq8Noo31I+eEZ7+m8GxA+4uEh1XcJ0UtVwsya06od62P+37wsfufi+aY5xCWoA9hrN
x7l42ESG3vrY9QRJkbaMaT13LiYozoNKD3r3BdRudw8BMVzcEUxQ6yLHez2EIjIHfUJTzhmJf2AW
y9z/i++jrgC0BDpucN+8/r6dxGUe57F1Js1LdbTYRiy/PVahfffn8/Jdf66qxigySGmXTfUC4fpf
rk0fIa8TIKVxcHq6MVu39ym8wYBKAi4J73zE9+vRMFDrjVoXTWcWJN+rZN8X6IvfsCGc8noXigYu
0QaF2jKee9IBnqcZc7nZq+esOo3jTt9C9G19X9rldZPahCn4fqKfq/ZE9I0VF3Mg/X48hFEqAGYF
6RhD2L/cFFQ8yZjVn4sy1NW4eRhTMDa75i/d0n7XY/PYGW3y6G7JbtwsDZq5LPBeIXSBnOpG7SPR
emUCxUZ3VlvqleC7AsmGan+K+5/rDr1oB/BRZGfAc3QzvEbvRsUBI8c5BecY74O8DtCZ6YXrVm52
PkYBZgQiLrsEUsdSZInGzq5zWgJiBykmKE/booFx3cSNH8AEujPA7IGLHOA80hmZEK1LtLHm50xx
Zj8FrWbiThu+sGgD5SOQL6BvGnnsa1+goMO0nMEAVjk65O3x090jAJ8wyPoECE6UkK6/7vAK6pdT
Pp2nR1Re43r3nz4vi7spfd9zNuPzg/OsHTq6EboW5uby18vdMbSIQJfQ4/Otso93pnH/8uLzossD
ksN4DEhTz1iF9guLTOf+WSuPffywPjkLDnr1eemGyIgFbgkbn5+yneO8M+i7dIvpa2GC8LQnuCDg
PSki4vXyWkqKPtSyVs8pj7z8cXK3APwLY4AB8FVgN2MjyPWOthxJBfkt9VwAThZDOQfk6n4/bOUq
lsYBK7jrimQOet6vx2G6SCBgP6vn3AqqMUB3+N1LAVLCP98X9i8C7tirbpWM+D5X3+fpqSj3c7px
M3TFoXMV1HEhBNJBrAPKpzftkyWlTppE+nzO4m5+UNSq2hNOWBDxPk4Qa3mYcOdgON0XnC3Dzxp8
4rhMDGqdQQWMgBVZAf2tYWSasStjOznXLRSnXM7pA01i5gMnW7wkPEl/4tXqjuBlVQdlTwZ3Djp7
sB6d2e73fUKKA3J7YH+eSvZ1bAh7nxZDNQL8DiU1e3S5pyl27GfOYJ4znXDIG5lV4NogrtSnGmSl
6uDkgV1MfB9xddrRKVZCvJX1fce05GCaJQsqdUggWQT40z6J0/g7GZMhjEbzq8L70TMBtvRAkNjN
IFe1gUsnsa9qIzvObgMye51Q7RmtuIrXghe+8hvFsD8nZcJ2RpImT01GWx98UTysymn+GRt6D81h
KGpn+dz5TqolvqNwdd9ETeUDd1tDoBNMuQ20Uz0n1/o9zQ3ugc5N+6EOtr3PS8s4j3o1D54Wm5E/
TaX13nJn7UfmOCP1KzbVIWK/GgNqY/amp0SRexroSNF3H39vjcjZQsTc7ikc+mjLQVYODo/HxLUz
NjMz2qpPjbNuJGBS3hvpLrJ+rDv87Ya6tiE7/NDVTQMg0VlLA/clqe+OnPi8SDIhSQA2TrkN3dEr
vSxHWz9bo/LI/RLY1r/4/cDdiT59KHjJgU0xyqZoYyxdjIuDQ87dlqKDdbNbMYILA+LvFxGhR29c
rI2mcZ7NX8zRvYbGYH5Ei9RWKmjREHKX6HDHcxEgWdkQWgFYVBvnzHkdxoMefZymLw65V6/2TaIS
FRb0UyDM3YA3rJ6RYcD7F02d3AOTMwXImDYf11fl5ikhdDCRwwSEB2WQGy2+OkuyrmlG/Qyh32C2
c68cX2rjQes+0uzXuqklBwZsFIBiYHhRcZfOZl6qQ6t2g3bW6w+jcuoP659/K6ZcR2uoH+C7yPsi
Yt8UpBgZU02Leu3csdFzp99ZPRxQQ/ITsKVD4I8/0vp5UGNf4fauqp7G9iO6e7zaanZzcdaKl0Ho
Rf7Q50N9p7AiTr/LXwZ2zWuHmXnn6LGLkaf0VM/eBNRnv3F1Xppc0QOMvmYctzdcX8yCBBgdGgIi
gaM6Pc0bOYXbAIfYAPA7+jR1PAFkTAYQ4XGtZtEMMN4uHR5i3avzDcjVoglkYoQmDJAYclEgMYvE
0Op5Rq30gPMFzJbpncIlWAfkXNByAe0IG48meePGaHat9MycAcixQOS9z5QXExTCY7txN7ldjGs7
UiRqIqucs8yazxr4Rn7O/P7PC4ZedCEJMklI2V67U1pSIH+UBt3etT+zAAj89Z208POvvi+uRReB
tB6dFncrbp/BaWWaYD1hxsYL6a15+HqvgnLcQkIajFlv2IVrE2ObEIhE0ug8anP8jWdRFOaO/Y2h
sfRzDh0gP9NLgoZ2wEy8vFPmvWhb81xKnqKkeOiJ6ve18qsxlVcyOR/Wh/+Wz7j+cbjko9tA/ES0
jcvOrqqdSnB9Q3zXVd8uHa8gzB/rDxo9MsZ9MrGgVt7Zzj4hcdAPe2jA7rX0VwSymbj8WhZH0hyV
rafH7aKASg/tYdgfeFbe6Jja1uxYHImHUKWN72XOnZq52BvX3xf2Lxa90nqoKlB8f6p/D7q9M0i7
m9iD0/Yba781EBEHLgyxOtKNaoAhHdewnvhZOm/47+35jKGIOCKqcsDFSOE2EViWGD3MoWGUJ1pP
r21VPQx1+7UZtzA+S6ZENzJuAoDI3TAddkg0RGlXWuHQDy9WGx94A7ACdyENRuKP6355GyCJcWlL
2pZlBIphymArab/oOLmG+KnayictLQ4CI2DJukAuyhmYzB0GsG1FZgiCbs9tW+/uFhW4GVocgRjB
BkKVWbopFwnNGTrZzRB6qaCa1b0qGnbYPOtTtTgMILshjyrYSWV4raKM05wZphm6TeKrnmLd3TEk
hiGuTBa0RASE/NqJwWPLoe47Yxgd2/EeIiGUf+iULYGlW8ySZEcK9TbpHcCvVTNMncjPRbtIru3A
qtWhQZ3t+r7zJ7X0eP5Fdz7dPYWC3gCujTwZujmlhXI1mqCr0FLDOkaWwHO1/fr3F7z56vtSvEni
dgQZO76vdBADCYzMTz+vW1jYm1cWxC+4CDR2mrlp3MLC0Ow15x/oE8U/6FbD0oKn4ShGqo8gAYv9
KS1Qj6NedbpBDW37PUvebzUdL80SLlxwNuxKEB9J6Uoltmqw7PZq6Oq1X/c7Gjke3ard3lTAUAC5
NCJlFKOhUsDTijGkc4HH8nc2lb5tnbR6T9MjrzeWZWNI8tZpGrvX1HLEsqT1eygPfXOG+tFpkt36
6osgf32IXw3KlRZmaoCTHSYMau6f9OiQ8rOaviNuAnThVqpr0RSQcOjfBwILanXXjjYTCNDobaaG
VvZ7yj/PJA+GsT+k8bmo2EZOasmp8eR8a1hB+7sc2dCCyfmUFGoIKougUL9F4lqCE0f7tj59y3be
CAtxBwIvz/WY7BzkaqrVqiGLD5qd+iXdJcarTn+um1l0hn95Ed/MSK43GRPpSMvVsBOak0rKvcJU
wEscbwxnyY6A4kFkBMw5zk15hhjUiutUC23nGJOgmj33w/0jubQgfsFFtIFCh6Ehl6eFrQ0MbnGE
Clw1bYxiKdhc2hCLdmEDqtVzkc+wkRmePQX5FmfO4izhkYQCCbKdNy/0eEJGVYuYFs7GN4M94xYD
oZz1aVocgq4BpYjeF6hjSn6Vx0Pp9kmhhRXrvf7oILP33wxIHkUKNTPzlmvhYH7u9i3fYBG77dwX
HUF/BvD294s1MJjV1KSrsc68eKpRP247vFZ1e/hi1/3RAme4NReHaGw/550dUCUJcB3aqeDhqaxs
B45ZqJ8Vrp/QMUh0pGh5GrCs2oBUL84y0gGCXwZzLNefp2FOG7NytbBPdqCKRh/FX0zyn+/LMTwu
5nqKMksLU+1A04d6K6Iu/n5gZND+gdT7TY0LVQkW9xHB77c+Ou2Hj+u/fim2QUFD3HJFPkMmU7Jm
l01NERNxqEJBzPUn69ANyW4Y+mDdkvBm+RBCG/0bwRV4A+SUF+m4qcdcRbSe6IPt5jutMB8mw/EH
Tem8aUQTuGNsrM3i6C5sSqeRmTs8nTLYRIHMU9yHuXgiOsT3ml/rY1sMFhd2pOcIjSzIY9azCvme
T+DhMEFpHP/FSw7cbX/mT7qE9hpv4WiwgRf5u26Y3nUaimIVai7RFn76rSC1tlbCJy82dp51djT1
kxqqYxoU5vsSWvD1LrXcwJmq3VxWXgx+zqL5Uo6fKhX3otf1+VxaN1CU4/6Apymyl1JkbNVi1kFs
hPk0kfJ472ae6ng9PaxbWfJIU2gOgEReUF1JVgyIVqIqhVEOybuMvm/ad0r/gScfwKmzU/nGVe+N
OVOe00trUjCmNdRcIBEjfFF9NGd3l4KjZzRqH3eYnaZWD6AyP5ZpFThN46vO/HUcWdDW8VHVtaDL
53/ixvHbut4Ij7d9GQjiF79LDuJTFbeJLtbazkrPdX/p0UNmI/PReSo7JpnrqRrdRVu95osr/Gfu
5Xti4hCItdXYmcSYAtBaf7IGJahSvoup468v85YpaXO2AMRaLMPGaad9MZyqISjro77Vrrt4GF7O
o7Q/h2Kaa93B8yRSsndUG/eRxbwqL5+1BqrDMbqqY3ShpdPZLNi+ZcWJj9bjVIPFg+Z7GjfHBq0Q
ULsJ9Bh81HRs/DqPj+tTsfSGhhIKksoO3B3weTFXFxt7SCuXU1e4PHssy6NtKXvNeOia56lBp38e
PSc17p7QqRxRAl23vXSOXZoWL4cL007WpRbcXw0bvsseqbJb//ziZibIZItMJVAzUqi3UK9V8BxA
yGK/XVzSc6hGQnjKG9uv+vgtSbawIQv2gPHFkSSaWoBNkGYyy3qXKy7FQzHaZeVe/V2Nh0nfm9qH
eAtkKCKDFDnwmBI0lzraTkH5dj1zCcugAJ3kmDlr+t04s0fBq1M46dmJVHRq9eA2T+l+VKb9+pQu
nGqwi+EhQqCOe6PNUg1JE+WJGvbxwaKBmfh6trFqC05xZULam0gm9WZnYGgK5Iu0+jOQdfe73ZUF
aVumat/YWY51ssGMBGYbcEPdqcEt0sVXJqTTkhXKMJAJJqLslfNH6Cuur8PiJAE8Ca/GBkKP9vX6
kziOWU4Z3tSUBP28AyYmWLewtNIgwwMAVDTI39Sj295MuszV57Coja9QDQ6ADvxVbCL0Fs1o4JdA
lhhVQDmPRpuEtnlmz6HiPrrWoVZSb0bT3/pYFsI9qnN/jEiroRSIwiiKzqFjV55Stl6UeqP2nKUb
rrs1GPH3i3jGiqGgbmZgMMYu4b6bo4dxw8RCMgXJZ8iNgxEb9EJyT82IpHTZGu4cxtrDND7iytV/
Gsy7a42oZgKuidytAGzc1Bqb1kqgRj2Hk3ZomkNTHADtWV+SpfskGMXR820DyggiXWmuqKpzHEfT
FFJCjpGQj8669x3QOj2FCGgJvLlGDjnvfrc6f7Kp4fdN7rf61pItbCT8DOAUkJcSCqtSLFDdXnGM
Wp9Cy6cs80ExeP9V48qA5HuJZvSAHNtTaACDDIk64ztnqpc393Yqwb0hlYDWEjRsAnohTWfE46pH
dQJyBaCt9NxsIxos3RJAcI43J6hHQBosdwejuNaC2FCZcJXpwRZMj7We+6X9lOnKHq2u3qS9WBHz
GvOk2j/WXWVh9yIMgVUO0CFxrkpL1EUkQ9JC1UNu7Vvnh10lqK7v9Y0S/sLGQsUCNReQBKCMJJOo
9UAuznWm6SFlz3nbBA2UG/n4uyhdKNJsYH0WRySo2kBnaSHLI937CaijoTOvG6EzvJ+jb1b3nmlA
h9EtiMySHaA8gfsBqmQhT9AQI2FshB3Kd4b5yEtP7zw0c2z4+NImurAjg2L5RJjdo4EqHJwXG6L1
XRauu8CWAem4QwIe+CgdBtTsER22bAvCf0t6hu0DCTgIEKCcAyyRdBNNhwQkgqVqhCVh6oGbXeNV
Wpd6qALmz3qMPFE08/pQW+U3wgfNw9MR8l+or3pu0m/hMMRelS532MYatrGOcxEp2etjJDcjvUyU
wQzL9rmG3kkBZbiNJ96yCZy5opCJ1m4pKnVtG6MSW5mhxatvzIifHbcEp7O5+4t1A5b2/81IUWnI
4mRuVZhJDVAEO0Mw/kU+E3P1x4LYAhdHbp46bWpZpRky+mHcjeR1fQALV3o0Xgg+OhT7bh9HqTYn
aVFpRmi1gRk9GSkuKXuaPTmqvwkxWFyTC1uSD058xFGBQyosOuIx4jsVcK5bKaPFnXRhRPKtrmsm
yt+MtP4v9X50NraRi74tMOrhcipfHCyKgl+fJgg4WGu9VJ6JPT2sr8hiTLswIQ3AHohaKBDuDEuo
oT+ht5b7lgL2bg7eHa8yinF/vz0bKX8LEGecfqp0+gDDwq1OLWCvNQKH555udH5WdAG/H/uPCdNA
tySKmdD6kIKcPUELyq0qI1TqY0WPx/VxLC08jjacBHiYgFRd2oqZbrE812KEUOYp3/It+pAl5738
vLQPi7KzplQsS2/szMxvm2fH2OiNWHjz4rL4ZwTS/nDiPBr6HCOIiwPw8mWBCsGxUHZozC69cYvW
aWtAkp9BCiWPwRUEHA4EdSfrZdA0gJ0O64siPiJHekj26Dboid4Yna6jF6jPjLbQqRGm2WuvZF6O
1uDY/E70T5VzyhAG1s0t7R1RjkcXGW4eqFtem0O/fwP9M/gyGkQAwf9k9UqQDtQbt0rm4kO34/pj
SJq8CJT4rCYwNKEX75HT8X2XgA0vS9inHNmMwKn1rbvOon+DAgDsqJr4J+3T0uVDlY2ZEY7jyUl2
abdxZ1v+voE3KpIfQsxemrtsFCRWsxGayaFinjvs1tdmyd9At4gIQISPy/sTxfPaYVVFQn3YQ6oV
JYlsSylzafkvTUh7lCXDwNACRMIEyhdzMJLHMkFfxIaTLU0UGB80cBo4WGcZI9XNMSi5QeEeZmBf
81JNn323rbeAUkseJsgBwRuDexveb9fLoaaVro88BYunpu/S2XpwmRvok4I3YtLsdbv215dncVQA
D6NNEaQZNyxMAyS2rVJDUczM/eRzv/W+WlwaiDljV6K7AKoK18MhTePOk5aR0J7i6JOdj/quKZs8
9czJUHzXHMy/OA7wxEf2EPQ7kAwR7nhxbxpmpdQMnRPUsp/t6sXc2o6L7iwAYCB1Q1+sKebz4vsN
2o+KNldJyLQ8qBOwE/3S6FaMXpw1YAvxiIII6w3os7GhtFIMFmatMj11tgI9UvdG9l7nG9flJUNI
eSJFDjoWdLJIo+G95U5OitXveo35mZl9JAPhHtGAN9Izrd1wtiXnvjQnLU4L8VKaQ8wj7Mx/wO/J
8n0E8Zj+o+5+WffqpVUSjOEiZyCuuVJQ0/AIyCC9ikJy98Uevkbzvtni2Fyeuj8myLUj1ATw6LmH
Cbt5SN1dNT8Y/EFLD+sDWbobXA5ECgdawR2al5gxgIzncR8/JZU32Ic08vTf0ZYM+qIxOLWLdBFQ
bfJmrSqFtLqCzZrX7fSgWsx8pSq38UDItQdzdFErqevBCpDXpCp4paHzsT7axTkFSQZuDiiIgnBF
mlPHyaLEyUmoxd27usm+jzxCfQZZO6+Ptpxx0UcujIkfc7GT4xpw1UlhiHzNrvlZ0OMm1fBSbBXN
06JIg4qGKQ0nN9lcuiK29uY5TV+scuPJsDyCP9+XRsAyAm1PlZIQaS2Pk59NcZz+At+Ea/sfG1IA
zyc6c7eHDR7Noz+a82d4PvHSsv+8vvbSYBCyEbbBAwyyLuSpIH1wvRxFBdVu5mQZnlhPDdjfefxk
DVsk8ItGQCwHIA/YRrD410bi0UgBlCBZWOuHeX5R3Jd0a8dKi/7vOKBbjBQHclM3if+q7VhRNVYW
MuZzv7+zyfzm81LEdoqiApUIPg8ymSl+rO378q1v3xf5YjTUiQKJ3LPU9snECiOnYav7zeQXGxn4
pdm5/Lx0ge4qrqAWjM/H+Y7RjyPqFutuJIWQt98Pdg/ki1HGQ1uY5EaxQyIQLxppiDIAMJ8x9kVy
BFuXN6ID6y9MoV9EdI0sKEum+VjVxJ7T0Eb3Z13EASe/1RGkiGRLB07MysWz499BObh3CmYBUYS9
dtsoo41aJF2KcxM0E8w6qu3sZxOKCkal7AhND3Tgn9ZHt7RVcB5jaKig44IgTeQMTXY87qo0JJSd
Rpc8Dbz5OEx31izfhgZAKxomRLHk5r6rkbJyjJSm4VyH8fyyxc+x4G9o6QHlnCZ84YYpFTycpELa
aQxJswcWvN2tT5JcPhA//+r7UkDJAWK2a2UeQ8V8yExzXxkvI/F543ha/ti7H+Lmy5ynPkC764al
m5Swa6NWhjIpqhO4uEv3grxwq4Fm+hDmPfPM4QfTn3LlYSiO1VYD0oLvAYiHTCoqZuChkyvjdt7r
hRrHQziXwOw/TTTzqvkraU719FlFJ9r6uBa8DtYc3NvALYsFkzxdz1k69Yreh7mbvFOodeKF+TFt
+411W3AL+DSoU0Dshmvvm7z4xdk/1uZsKn3bI0j33pR8cruNi/WWAWl9XLclU913fdhAt77cG3dy
fon1vxqAsH8xADQit6Yhvu/k32MlGNWdvSWPvLDwVyakAICWgzy250EM4YM6pEHFWoSaF0tlO6d4
qgr1fpe+sifdZlrI5w6mNfahq6DsRgqPzZOHX7DP2lPjbBhbWh/0IAKciXYxHNNSI0/qdgMrtaoP
afNqQvT9w7obL83d5eel90fXqUaU2/j8xLw8O9A2cLsXbvo8OdRbKkkLW8aBPg64eNHfKtgQr10h
ds2cO3XZI8HyorV4lM6fYjJv7MuFYxUwKhs60ALMgNLetRGSo5HEaEgXRlbQgzIbDXhe5wDs5Qwb
L56llQGlObpccbSCfUqKAIqTUaJWcRcmSeGlxo9541zb+L688lWh9MYYsy5sT1wLsjvhJW8b8+Ln
ywCWQa/yLG7x83XzIaVP8/jIt8g7F9YCbEwoWUOnAoRGMosZ56MKDmbWAoX9iLOF6cdyfsm3sNgy
iFOMBGZQ9gD0AnUCGZExZSzXoC3Tho7Re3QYvaj+UkTfI/JpYB/Rn/spOfaWZ5+SX4rjJ9aea765
BeK7HSpa+kEaAQFDcFRoshhxxd1Ec+ekDQ38BmaAP2U3t9/K8u5bKSqjgJsB4S+arWQQAH4DyD1j
F9K6EHiry9pL72wNx2ReW5D2D7h3SrcWFvB+py3UrYL1gHPr1fg+aBDeFFSQLJZ3TWGjyksJD9NP
pfJrLL+tf/42xuDzmJs3X7i9BJCaNX2l0haXwaOBriDm51s8DjcjAHk56LLBp2JCQhI8wdcRpqft
FJldrZysg9unHrrBN67riwZAVIrigyClleNkFcWqCn2X6MSey9jH+XLnFInff/F54coXJ3JdF/nU
m/h8zAKtA+278jM2H9ZtbA1BmiPepWbWRhSc6J3uQb3KG8hGnF+ygKozNj2BFODNKrg6RxNG3Lmn
cvoWObs8YX8xTZcGxMl5MU1W6do5cVv3FDUluH94DCA2ZDSeK+RQNmbrxmmxIoiSQBLiLYjag7Tn
Cl0ZaU1K92Ro79B66NdIcQ7TfeUTvCJR1DBxZxXd04hU0rJPMUuMuK6UU2p3UMPS+vIJIMli41Bc
GgpI3yDhi4o93Ey6TvZ5lnXDWMeh042h4cZP9qAfNM6Cdf9aMgPhFrz7UW26pZ5J3arJh5REJzuz
Ti5a26k6oKnN3HCym6iOOYMBQIpB+nhLPlORylZyXYlO+tjgLjn4Zpu+gFLPB4/WcX1EYkdcvZxh
CgAYqEppAPwhMF67G2uYAQFJNw6LolBfmct+l32uB0KH1XMSq0du090C4S/toUubUizWZ23Khz5J
wsDgP3T+Y31Ei19/i8VwPfuG+tEY6smqtSYO6YTyptvbVjDHRbRbt7K0RKjY4EyE7jZSwpLDuRp6
iVrbjEOX/ObTt6n6Wqlfx+L73VZQckT94Y3+H+kyaXUms6OtwxLgV0tIPfhtSzzDLIOWbuVqbi7k
Ird4YUnM6kXY6dI5G1WVJiFPome7ycMeKGbP7NvvhZnuKbFf84r8/IvRAS4N8R9B1CnzUQwptcgE
hcdwQqdgSpmXmQd1epcCsb9uSEZ5iSAkKOv+Z0ny8sqBTBtp7Dhsx4wEumsxn4LzZscNxXxNFTJ4
fKqon2rF7FPVrJ7KaoYoCYOeesfSZivGLzgPhoucN6TpoOMhAxtdmhWA0vM4LF3Tr4uzgv5y3fhH
d3+vj3shXIF7DZU+yMeot9BGrZ0IiL/aONSsCL2Yaa4diNvFflGlWyL0Ys9KceTKlDTDLQOCs6+m
OJyn/qRMU+GXM6MeaSOPNbM/5643z0PA+mZDk2HRcZHrMQRxOPLW0hbJaTWRwVCUE9pbY29Oq9/I
oYvk5vsoMT+pU/fViZqtXsLFiX1j0QCGDr1pUgQba1rkg1HFYarXh3yodiqIXyM7vz/I/Nt0jPeF
aAqWrjNVqedGbSVxyEZwY80T116ySat3neD9zgCB2zhFlxYRuTIbFQYQbQKFeB0ESk0HjGtGUIPc
MH/M8QjdW/FUvvTdO2Xc0XpXaBVFiWvc6n5emk8cQBpeUUt9uUU/FyRhWhzqRXRIpjQD/Rjo/o14
Y0KX7SAH8GYGKPfrAUZONuASjYhDzL3ZvzTd93ZrKEt7G9f0/5kQf78IpLilgaUA8MewbnKvjn9w
6KSbz9lW2WnhlMN8/TEjuUaLHIQyVgqWKlE4mKiyb302bITNxdkStDSodOCqK2c2maMOeu84iJpO
u5vtd81s7vJui3d1cSQXVsj1hNVg0e4mDWuil810yuaGPRSOsRVyt8YiuTaPtLnqpwhjidFBOukq
Wg3wZG5RK1iPucvDAboW0X2hRdvo+xjJU7H+oxsOKnJnCd8IeUtjAbIbYHyoJUBoShpLjeryzOkQ
nRzcFD0IkOa7ZJje2yPov+4fDEEhEOpgGAvyzddrY9mQakztAk/COHnNDes0xWQj5iwORjSzAf3y
Jn1zbSLpEG+UtoxOUM92A25MPwd9ip/c1sk3KndLOxOPA7QFoqsJrO/SlsnATFmQKolOnLPa10lj
oksn9nEXrXyLOf9H2pctx40r234RI8CZfGWNkjUUS5It+4Vhu2WS4ATOw9efBe0TvatQuIVbPrG7
ez8oglkAEpmJzJUrve31vZMtDJGE6aGwAlin6OSbKR/MvoHxbqZth+ltjrMfUBv4vwnh2nhibRZL
68Blyz2EH2TOU9Y8Zqr5ybJ1WGjRR4WDV4hEJ2ROVebMegqbGW2cn1G2tT9uX8OpACF0mPHSAm9Z
HId9VhqrImrrjTU5YNftSxU8UbUWwW+7s5bZUYW1EBhLN99Z9ge5EXTwGWsiGEGyDJO5kW7iv+Hk
SIoR08yrGgFJAm+dfzHasP2LNAePd/4VIfgYNph2sTBHO0Q+WdEe+aZYUZ6R3ZVTCcJdceJGN+IJ
i1iy7TTqq3RhmzIqV+akMJeykONUkHD4i7cshlHj8At/VWX3bHjy8/vWDCwvSHP88xcGDQ10CAFB
tQv0rbBzpemh+KxhXSB0rcs1RVv9dWWWmX90cOAlzW0aAPHnp29EWgMOEMy9Kqp/dPZbVQ2WKTCs
Pgad8fzTRUQ49vZgwQ0jM8C0dbQYT3n3VqW2wqrwTReDeUy1RekWiWU8U4RF9DjxLk1LxNQlK4Yg
yomzi12zBaW01kIfknmXp8OIVhkwaCvA3tIN5MAE0D04l2Nn7Yzkne7k2sHK8GzQK0xMUqicdA/x
cge/DDoQEdqcH1FG4enGJtMOzHWKcKpIdJ/TytwXLcB217VBdo3QW4bRg2h35OyU56KcLmXlwBbt
YE/2eiTvFhIqafYd91dxYtJdA4SKNypgOrAIIm67avFqCrUzk407rBP7b9T65PvCvWmHJWmKuNMO
fvzgYgB5/XZ9o1S/X7A3JrMRA7j82oxroKmCwvt+XcAngceFTp+sQDA0TdT6XcslpN5KLwI9DehX
7bcZar/1z3+BiNesoPljYq5fGkTmPnq5/gukaoeJJCZCATBwfiIlTvyClnqzmUYDjHa/ScCb6q/0
UqFuEhFIfnpAIyB9CGIHIaFrLPoEyv7EO8y9sdaWeRUt5nOlmlLIz0LYyTMpQsA+lqivAZzsHqrE
/Fr4xbaa4kPqo+YRF+OHlY4K3ZbK++x1JxzyS4RLVBM36hqn8g6RHW19jLq3B4ygQq5qNTXmndGh
0nr9pCTKiAcwpsZg5graccRuCdvVzDJJGu/g0vHn7BdrMt9I9seDBMQ0YIzgIxT4+M1zw1DDjnfe
UrkHN3o0khdzfh5qRUlKtm3wRDyoBjAFgO9zEW00LjNFW/rB0SrweeT6k5a0UwCGhW+2Gw1IONG7
6/smshd/rupUJN/YExVvDbOO6jTFUIF+3Gl5u4vtapMU3tO4xIGexFuNejv0/X/th/aZYJTcyPKj
MycP1Mjv7KS5A9GawuGLlDb/+U281xGdIQ7eGIL2tFOymH6M94U5xpiCmIZjkW3oUNx3ETohBvah
x/hxdYm2tcT85/qGSPwob6QHOAytV3DYguwJoiIgLPyD2efdznIA0e2MnO2SJmabvqirB5bQXzT3
VSwUl7Ar6BdmfcLcADLCGxjPTwId7eB/jTT/oJe99bAgibmf2oI8prVmPwyYjL2rpix56MH8eyym
hmw6IN3u9KL7uL4Dl0Vy/kM8pJKQVkJ3gwgonRw37dIGVT8nNe1Vk7VWEC9sfMjorO9TNxt+FHWe
Bc4Y9c9NmzQPZUN9TKBurNeoNap1XNFyFbGp3uk4Rgz3aLT6sazj7P36D5Ue1cnvFG5Lr6OtZEwx
DwPojmSVMDYHFULst24eoxUDwHo3tsRe+4mSMURmtE93SLg0ej0iY9Cn0aGbzbWX3OfOvNZU5W9J
IHJ2DPxHnNxMTC0BA9EEIUUeuMYm8bbVsFpcxatBZjgBDwCeG3yfKCYIWpe5dq+NSewfGhNjEIdm
O6WqlKh8t/4VIaJTRgBfSsS+3mFcsq9FqX3VAfUdR2UILJPjAGiHGo+JcrgYx5ejpzlOl/iHAZOj
WyQ9J2sb9x/XlU62X7D/fDQBB5OIuWtq9Fa+6LCXJebjmJmPoOB4XYLs3E8lCMrlLC0xogwSqmXP
vH3t/Cp+m6bCX8ruDkYE4IIj64VhGULY4fplaTe57x1I5a4aEMJR/4fe/wO+1w3uy8q9kbrj06Sj
TxZFWDzigOkQgtFIL3NSpbp/qM37sdwCent906RnD0gsJlFaAI+K9FHUt6KIjsQ/5J5lb5wcI9e0
pfHvEtCMq9wTtytiMAW8/b+yjPOLWSD7xRp99A+T5X3Yif9Qt86j5c+PVcGA5rHDsU1/OpERjBW4
9Wx/PQ/GYXINReQo1RNQfADvCV4K5KvOf8aQtNrczjM0sTfLJrBy0/6dNXMVJCwrfi86ZXfX91gl
UAj4KW2sxQfz3aF6W8DZXlk/UxLU++tCPsOoi911PYJyBjgzgWs5X1YZp11GwXd9aDE46k7v668L
M/TVHE3545DlnNovm9dN7dhvIDEx73JQia/dJWerAZ0QhzQZyvWSesM+WYp+Z7G62bZmjybK0h/R
3IgxbWOWROtqqI0HOK8qQH0jUSxCFsdxUCFI2ogBMg9xpzptxvgoNzpkJt2Zzt629zapNw16P3IV
L6fsVE5l8Zt+4iZ0UE+jA8EHRqdy2dHT82jfz3Hyj5dU3YoNdaSwHDIDCC5yJBfxPgaKXnAYWjXo
NDWK6DCNW/0Hu3G00qeh4AhJZBIAcLDF+MvWWF5WLeBAXvYFvN2ZgjlGVlbmpLeYt4boCEgAwfB5
7aQPrLCig5bG84tTddnD7Ho0GBGarcwm+TkskfOozbZ78NzS+zVrBHxHBdGH0C2oavKbdDNBSW8A
986nfQvK3sUR6Gd5WcBM1gT0gtr6+m2SmXk8JtBtaYFU6wLvuHgV7ew6QWJTq37U0fi1ZOUGY/OC
FuNIgqZgf9JIBeOXyuSTPUDOwoMkQUHcwSg71kEhR+0hada99Y3VxUob8O78WZNEUSGQGX40oqHH
G0kvzpZwrv4MVZTYjXDVzOWwGL8pEhHohVJso/SYToQIFp9UGGXY2l50IB0I6JIiUNUEZAI8AKEc
H1knDu06X0VJx87swah5mDe6eedVik1SfZ7//cRG9HrPEHPhUiWT+cdL3WdU7NbXNU12Dqcr4H8/
EVGPI42KGCJm/dm372PMq+oVd1e1CsHhuX6WLEzHJrVPZHhpEsXnVSsQjHbcg4XRdWMYNkLu4zb6
sZTkySWeIlmqEiPY6yQqW3uOIQazoSJzHfWr6cZ+7k8byietoQKkA2coln/8tjTLeHD9w+ytPW0/
eKjRKWIB6VmciBBWUXZd07UtRCR4ZZlA4Si8jMyroXQFB+OjKwglrHN1KjBQaZqGAUaE7KIY1YVt
s/yobyRZ+M9GmQCdE7yAeCR1LsWkhV+6pIYz6FfJc2EF7UuhasmVvuuB1fxXiGAPe9jCASjE6NCU
GJGJgYF1Zj4O0/SC2LwLag9viH4pPvplWsd9u8qZfrx+NWXRyMkPEJ3MxBO1XYMfUJRIKsX1l6m0
H8bSfMnjaY1G87+o22NupIMAAbOEsG7BFNCsnTIwNvsH8MP3805bVkq2Xqn6mSBggCBkF33+9xNr
k/loD6liPP2bxN3mNvqdHBVZlcyNoTcRCSi4F8CUBA1cjBRgDbwAD03q5Mh4UPMNdWNjS9xOv4/7
rNsjG0nXQ4323uvnxRVCjICxc/BpeJ+BD06QbIKxr0g82LlyoO+o6oGN0MTcWXSnZdXGnwtjpYFq
qlRyGknvHCZaWpyu0gek/HxT285cTLdfgBzI5mGfaybCBMTVu8nRyArJ+GZ7fZ1SeWj0MzFWF5PT
RKIGvUMsRlOk+VLzNU7/JP5THr827O26FJn2c1oL9PkBx4O27/NVYUILzfPR8A5A1W10hD5j9TxW
b7RGQUE1QUchS8x0DEjvU42aSHv3v/L4bTQwEmrFQMU81t+vr0p2AU5WJWqnEZPRGUZIGoy17q1U
E9RUnxcCnmxsHK1D2uBAvZ9j/X5zBysyjGCZwOOO02AiZXN+JlqWIwsaOcgIZUGcBYOKn0f+8//7
feHMh04zMckG39fL96gsQCStKq7JvPh/V4B00/kKYt2Lx5F53sGpnkxnZ0cbEt1dP2Kp4ziVIdiB
ZnJNvCN5jobEd1Wmr420u8ez6a2ttKPnj190qzjq2eCsq854J+Wk8MF8l0Q7dCpfUIKmNVHWhec8
DB0Lcu+tWHZ+4wbD8MTqJMBQ5XH+5/qSP936hUhk/NHzh/QzMmzn2xrBGqRdmXsHjdTpsGMYP4l0
8pIe+yay/vHx7HzW6YDkM0uj5LFz52XXNhFFPSbrg5gl78M8Zns0HNTPDvLkm4HR5blIIgwoyZNv
VVzYO61yGmRqxunWfiuu0yc/nevkiUtq2gpNbAv1DnZ/P7KgjxTWUmpb0O3N+xWBkRehUEPtN3Xs
xvz79RblvN0YmcFS7ayiWqfWjXMzPyMjcOj9K024oXgVAhUxZCA2K+5pdofRw9dPWnpDQSgBEly0
VV4w3CWVWetDXnqH2jfvoqZ9G0zv93URMveCt9S/IvjfTw6kNeamqd3UO1gRwyyE38jVrKzoSze9
XpcjNQWcDwVZTbT7i9WquKdVYtdYCuqrdJU7trZraDltmK/lCpMg1QEg4kEDBQVAB8j5kqgJy4Za
i3cwWPvI+mKL9/39kCfHBeMth8nZXV+Z9JA8wtPEGDZFxFdprGF2TQIqIiQv7xq6V0bGskSqjxcv
mEWQFgaD9PlybK0hdto1CLH6OfuYUeEES3Hh58GE4fE7vfON+wWVgwWYXChgjQbRfZkBmhHUVJ+D
pGVaEJs5+YtUMscaozPTxk8T2bByrWqdwUERdjGsbdRNW4etG+34F1vrg2oLXJW8c0+w7Rhyjwml
be4fXK8PnjqmoqWVHB2cEseVIBODPlPBAxZWN9SkQXxAflDAZFSt+jLfZKI7A/Vw5MGR6RQMNatK
o9UXH0kyfXq2afKPaRVrB1y/Xqq9JjmwwG7Rbgx3ONal+VAtKi4CWY0YaCdQTaMSA3YnkYDTGLKp
ZpUDRIPjBa75aOZ01XYvWcGRwsO2trtVUror4iqCc4lVOZMrOMXFmGKm5R7kuvMvv5rfme7tJyte
gs7E8LrrWiIVZts+J67htA6CFS683nLmyMIujyjSFE+bCv9xVZhxqa7AfqHxGqQbF7UgMlNTHxLd
PYwrEr97+Y/ri5DYR07WDEUBNwUiPm7UTuzw0jhzx2YgXFjMXuw0/TnbpA1aUuyvy5FuFuoGGPqG
VyeYV87loLdiqmYXGJfO6py7hM5NsCRLtLbc8as/UUdhiz/HdgixCtCC4M4FcyLg9mIrVFwbvdtj
uOABDP/Jq20n8XNu9PrRLUz9T7r44EewDftbV2P+z1IZRhMQRDePKLpDR4dWb+5Yn3qPXmqOa5q6
8V2dkH7FtHYMWAPeWkwpn4KuydxV0jbjQ2IvejhZTRwMmAm3cv3If69LPH2Rm86xnalqeoFwbuhM
56W6/7JkCco39PBsugMyONCa7DBjILA0IOFUGWpB+S6kCIaqTiY6MQtSkKtPg6Z191HpKWrcgmb8
R4aJuMkCXy/YOgUNLIbZZAPQV2BFW8eP/DH7OPXr69on3a0TGcJuuVHDNA2mEmPefiRAj+v7fvjz
FyJQ4ARpAP/fRW+HX8aZXmGrjPy+jL5XVhqQUVXeka7jRIhg3xjALnpnRliH/UwaP6DTxkqd1fWV
SA/9RIjgPWhfp4VpQ4ihAbB1b9xObQ3nBxAA3AOQPPCC56YgaslAp9E2w7bCmIOfI1FlWC8XAO8H
dhIkLkDEiETUuYCFGJhJpWEAwfQFiJOg7OjNO/SJ5UUiBvNKkQQVrkWkz1MD4DsYbCnZeFO2ShZF
HvryUnBCElCywnIBze0J5rKepqXpJmKBM3mOH+JRfwOPAQYH5tXRb1KFbRYCV9xAuAD0KiOrBLNi
iti5OBozJ+sLK6y79ZJ9bxYYEjibH6apuIayg8FNhgx04SFzx9X7xNm0zZz4adNZYfSI8VxRqTD6
8s/jwYKudUBCbUFxp85oB5uCWJhkXwbkFdqXWy+GiQc1wMAogOI1IaZOm3KIbC3FQPl2XuXDrjMU
0cvl7ca+IG2PpClaP+G2zrcncfPJoz4gCrWLESr71MEAT0XMItkipPQQdYLxCslTsT5sV53ParyU
Q72Y9FeW+uMPbUoshUJ94mxOvC/XKFC7ggaBj19HmVG4IH6JBriumwEEnnzMLYVzJebPaUJ6Ivpa
26DJm4pdk9630/MMVsGF/ZP3igskWygQCniFgTIXNHbCL9AHjcW2pZFwG1lkV6WqLivJBdVPvi8S
uCzVEvfESHQM9pm3cdtupjIJjEbbRJHixSNbCUqniKOBnfFAjX2uFTZbGq0q4busdt489fW0uVmr
UeDG13WT17htwafoVkmrdMwA3Pa+D2Ff335p+LhqKDbuDog1hIPoXVLoFlo70Fe5YuNXS9W3Kbk0
p98Xs7ptnJeu03gm5kz+masHjJcM/Om2pzZXZ1CJ46HGKZ5B+S4cQWOXaWLroxlmuJPpj9ZS0S9f
LgLN5JidhGQr7Aqu//kZk24yu47RIdTyLeLPKg3SeH3rMUMEUMsO2G4AYhUD/TiJALuykBcECWaU
8OeYIgC6vBEQgB1CNQa9rQCpnq/B7e3EmlxtAF1ktYWTWtXVutW2uae4Dyo5/O8nToRh6LKeTZAT
g4O20damybaRvS+0aXV9x6SHwnuCTDBCIYwQTr3TjSKfKmMILbNcNx35PfRuYDrJ7/+bGH7/T9Zj
gGp/tikQLGVnbc0mu8tZ9csz85/Xxci2zfIJanLgIEQGV1AxvQRx9cL6PqQ0dM0Uk/qKgNrzum1U
mCcev50bf/AYAyKNcB7mCnf+fEF2t3RO55pdaDu70j4M/t6Ju8DLXsf450zfry9LdkgAZoDqmGcT
LziWWrvLwGyvdWG97BM3zLO92SpciVQEmBA4KzaB0Rf0ANhcI+/rDPxw1AoYOfIJUx7b/MU6XGTa
QLkDBhkiWGEQLVUZckVdCMoga1pbemCrGAhl6wB4BUkZaMFl2wdJtCHRLOhzzl47zHkpybOlmrwi
0zIPXWB4AAGDeUHuT5tez4G4Q/Uhye5dcJP6FShKh2bNbE8R7V1GrYggQYSECRwAF11kLtLMZeAV
z6fQW3rks+7GdINU3tocXynIUG8/nVNZXOVP7mjU+N2IIaFgQhrfPO9rA5bfOn29LkO+dVzJUF1G
lzM/vhMZTZIZU1Rj6+Lph55uJ3rPlpWnmvagksL/fiLF1uNSpx2kWNq002N0tmE2vGs8kfZwfTmX
YQuOB3pmfs7VvkjAjHHvJ43ZTiFGVgQLSNXzWeGVZfp8KkE4FHtifkb9Zgob8/dU3UcUQ55VOAMx
lQrXb2G8HMjBcW9wLR1hv0p0Snn5XE5hRL9V2tcCSe/M2VhIg48xDeKqXGnGfWM8NH2tWJ5cNB/I
hbc4InYRBe7FXkIH1xgxrY+9D655T0v9JWP18+KZG3NxVnNtfrE5Mb6DgciL03y/foL/jx+AxlFg
OECXIs40YMAhDKMBXfGaY2n80Ydh3RTbWrsj/TePbnq27/QHy7w5H4Qdt/8rVbCE5dzNbeFA6mwD
jYOQqF7P6S8ls53sIpyKEax6TfPeprMzhrX37pTfWbVlmIjnbq/voewWnEoRnftc2QnhUnyXAvqd
Bokifyuzgj461zneF3yMYljXFEsV03mEkjSUrcjUruMl32m+t0lJ/B2VjG/XFyRz7hgT9+lBUH4R
rZQJCzUn0TKGUZ0FRo0OJ9ANT3f6aKwNjDMHAvy6POkGotuOE49CD0W/6Bcm9cw4nkL2TqM3y1EE
X/z1IcYq/snnBS3I08jwhgqfJwxI/WTtxusEE51Gx0ByNyj8YU00RSn6UvFsG1R0BEU7ZBEu3ltA
MadI3MZVaFVvPkAoFt2ksbli6ddbd44nQtAKiQwVb4cRVE/rh7IfLL0Mq8CZ45WPf68LuFQ9PjmB
c1nzFlxHtE9LYpQTXeYyTLa+vnH++DPGuGxyhRm8tPJcCpI6SHDhH/Ehz4ucSzpAStYkQWAC26DC
GV6q2JkE8SlfZUNue1yC7m3zGEGxYp+k3+edgzZv/wck7tzlJq3Z9sxfsE/0WKzMOPyLY0BmAEhS
VEUvepSXwl7GxBzxeXcOCmA9s+G7pq11f13hdXRdluwwOI6ODzUG+k28/dOYu+jmy0pMFH9x8Y4o
Nxgfd13EpYGxETY6eKbyTrELNuZmsN0sGcYqJGkGWtP7dnm3MbMBE+43abnVSKWw0DItPpEn5g+o
009sytsqrI0h0MH6Utnpi1X4ekBYsY/LQhVSyPbQRnKP93bBs4vJhA7Fa7u0SBlSkn4zJooAia7m
3FesS6Z1PPfFB59+4mfPtc6ipVf0oBoKK3Dh3c2gtr5+TtJl4CWB+BvMEihmn39fG+bCK0atDNGm
ixlu7ofOe+6maFQxdEiSicgjoqMPJX94not+HXMyYAISWsHF5UHH7rT6rgRRO3Gmjant0WXbFq9L
r+NHVIExPefl5vpKZRpyKl+MM62078sF8p2M/Wws/aGIQKgMYudt3JQHq/QV/QCynQXBIAhe+VAC
XezGM2hEvXaOwdycr0q3QZA172v6F+pxKoQv+uQdsPRZ36YThIBVX6uD6Hh9zyTax/GDmLqIMRjw
DoLNa2c0dUVd0YR2kKJGpbJD0s/j47yJC0UY0Q4lPigQo3JmGMGJeSvDt0oR+kq/D1JaXkTAZDxf
iEEbLaITbfD9iH0tdoS+Xd8dyQlzNgkXj3GuWCIxdIQe9rgH0WLo98nWIc0mc54HlWGTreETJoNk
HJy0iNbLR9bWSJOxkMY/O/Bbdzdi6vA04vUihJ7/K0A4YzK09oDoiYWG8622/vj6y/VdcqCC57HZ
+ff5Lp6oKG0HjGfoRhbORRQM9m6KULP/Qtj7dTGS681HwaCTARMNLpmOq7EYqm7BmJuCNGkwNVYd
GGUSorD4LRq8dy3uFHdDevogMQOeAyD0C8wz2kWrvPP0KrSHakaymqOnYveL5oNe+/rSZCqAWitS
Vh6o+zGS/XwH54qBV3My6jDt1/NrqeIRkX3eMqFaHAvvo9Bz/nk/AmG/5+CWxExn92DUnI5Vn2Sb
2xdxKoWryYkalMk8RF4KNauIdp+NFqB1KoYxyUIwDhpFEESxHPIlGEPwSOjJEBtdCMbh9n4qb06F
oGpw8nnhGJYaBiZJ8fneWSeHhexu3iD01+nwFYA3Xpa7wZSHhE6Nz8c/rP67qalwThJ9hQ9HKAZy
J2BoRWNImafVmNHVhwQzdUFpjEfe2r1xiBk3JhACRB/S0OD5EvFBbkq0oR6LPixstso2UaqaLiGx
JqjcIouPzALPSguHUFVpkfR21IWz82Vi9+n0ZcZwZVV7pWyvgLhBHheTXgDvE6IiMCLVMdWwV/NS
BHH50RofBqYR337gJ0JE5OcAKEvlDNir1n6vV32pcH6SNYD26rPFxef3WrDrk1klTU/0NtSiHTVW
zaJ4sKi+z/9+cqF1RryisvF91t1r/isa1BamMLESm45HPQiMgVN30CUkHIORIH6fvKwLW5xwo89r
y3hvy+NUHuP+282H4fPJdRiGg464izwnaRu9nzB/L3zX/TCfFXt1aZkAMwBrG1AyQARcpOD61rc7
IyVWiEm87T7qFKGm5PMIz+CCwOKJjg9LsK36YtgsKScTFjwOmoYGzubW3UEmG64BiD8bryyxdtIT
zZ1QZQK0JP64H5J/bv86YHpQUrCdc07dc03Kh7rT0XFgh/Nj3j5FTBGASHaHI5TQAoOnLt5QgqJa
6PXCsLXeCP3c2Jrl8hXUQ4ra0qVVQucTXrugLME6LooYtLTb1Cp1DLtsggR0Pv46avZ2r0g5Xd44
9E8igYzqO2RczNiY06QjRT/qodfFm9zZUJdsS0c1hUC2FsykQKM3UOnYCmG7aquevEirDcBXxqBy
77R5w+aQWIqMp1QM3pyg++IMSCLHSxU77uzHixFWerknNl6CS5w/IcdKQHJ3IzMKrDgyqxayEYhA
dDwHBK8BruYk16JWC92gbL4l0dfrCiw5GMwpB8oer1ogcD8z8CemMB0Tr9Zr5oXp0L31WQQhZuDr
2tt1MRJFPhNjnN+TNLetuXBrLywMTD1YgmFSnIlEAEZeYNgFhgLgqotJut7p/DTXcRGt5rfxamSK
3893+fwlgBsCOJ/Bs2h4ywiaFZnUcMrKsMMi/x13W/ZOqocJzZ7LNp3+3LxVOG80lRoEdeOLerLu
tW2a1SYwWBsS39Nxf/vnbT58AkSmPGMv4PoW20yWgWhOWBoBRf1ElS2VHcTp94Uqv5cSOhM9dUP9
pYmywItVrQuS24ewBskroMeAhzGFoxj8Fk3ZVayHZVahWbMLsgRcTgwUEvntWwXYFmJa4oBxDYDO
c6WlmVZghkRNwvaeDodoVpSZJDt19nlhpwajpqmWtSTMAjcK6I09mtxwnH1euHLMTBtSTPh8aq9B
rJi2ChQM32fhSvDme3C6wg6iWCw8WWra2wuN6RIW/bF3wO36Y6K3Gye4bmSVEfnzJL9w1LPGhlqr
0OE8UC9o3XrlzvfWpDgG6TrwpuC9pgBAiZFaYpFsQWeKHnZGHGRTOLVm4KqGI0qFoOcA/o+3a4hk
rmgU7zXaRCRkxfNif0RDubJVgEO5DE4UCjAbB+udq2tPW6QIbQACHeM+zrrAXp5HQzXUTXL7eJ4C
IRVKIbgYwpFMRY1ZXBklISn/VMZDlNxFGrBWbzcbqTMp/FeceCUyu1ZTod8BEwU/KnLIVM2SEnOO
UU+gVbXBecOT/OffT3IKWHheEsCnjxZIY9s7v7gzZzTp2HVQpgpyf8lFRwCKoULIFErK6GOc+W7W
5ySMBnvjjv63uVcpsaRSDvJjPFsRQgMRjot/vqJoQHm3LhoSGmT+1YwGuCjtBKgHts9RxE7seu9N
1sapnI1hZc8NvJniSSjRPrQvANkHwDjiSbEWV48zJRpaXcJGe7PnRzO5y4e727WC86rBKWLwGM7u
fI1dGjGtxJzP0KHugzl0T5E/KN5SMvUG/Jnnk/BkuABY65EOnvSci6h/YQBowPwyGGcbJdLbw25O
oYAXCU4NdLHCeXU4BZvVI4w/qZaAla4VkBl0G6mZrhibbjekAL6igg3wHSr0YmuIl5Z4ZdQOPFmV
rmxwIOXpS5Qm6+vnw/df8AhnUgSP41WpZjcYrhMWmv1YVH3QlT2k/dTSbucQhYm41LfP0Bt4T7Qh
IU0rWLuuaeImBRNsSHuGSrm+Qrf7xtDery9JKoUzB/NgHzwUwjFFiYMiVu7OoR5pceAnIJEaSyfQ
lOz8YsMi3DXW819JFzVgks4Yo8ol6UZQFC+R+80v/tjpa9sWAenroE7+P9IUl/qOBg8T8GeYdMwf
ED1sn2nEAvvFHI550Gebug8wSmVR1Z9lu8i7FripxRtDfORHhjNhUOeEW5U2QGHNeOgffPr7+lFd
Wlks5USIYB3Q9t5ilN+8YGI3uV/QEWebrULBpevgzhUJHcAmRG1IR9ovDuiZQtffFcuzNj/3N44E
5WqAWgC4voGbQGwrlt6WDP1V6Pytjs8eRlzhIaIw05JdcvGwQFYKSG8YUmGX/FYD0hgUnkc7KgNP
z4LbO5NQVAaVHBKdyD9ifOq5kTYamxZ4BZfHPl/P5TZ5u/mUTz8vZmkx8QXW1MXnE+MtXrZO8voX
3wf3HyA53AuIIOV0alKdenpxXLoxQLtmUCnCZtkBAJr82bmFdJor7k9c5M0cF8UxC9rovapufgcD
4AF6BrTNo2frgm1gISVzvYnUR6O0VkYbkFLVyXgZO0ECeFr5/CC8tUUvXFqT3umVXh9tkGKRoPK/
UD0gxUNJAYBVeMnLzYIs4P54aQcXQ/Rb5pCOrCJdA8TzA5u/1Etz83VAvwC4RFALQ6/6RZ+6kQDq
lyx2fUzmbF04BVgDFEu4dIpcAvBW4BfCWE5RofpOKxdSLPVx3fpPvr/u+5UT6CouFtlGIYmKoAhw
V6TZhGtdEDdt49FnR6sgGCLir+A0br0YWMeJBK4WJyH55OWo8kyQkPflakzJelTBTS99ESSgtQXU
FTzPbPA1nkjwC9fOKp+wY53dFxUgafu2v+9u5P6BgeVEjUgRIt+MlBrhv+JESjwDy7rgmh/bjm11
LygxgeDmnYIQkNIB+MKBdsJZuAlNJj/26qOZvpXVob27+fMgLIeRBsUqEueiBdeiatHzNC2OM6gI
6aq83UBhkhZqkC6OGynHy6dq17l+HuXHLsEARNsMOm1/fQWSg8YYJeRVAKnjJyG8vnQ7XdDz7+TH
3toy7dFp7v1sjfldN0vh2BWb83rh/3zuzE8OOnL0PPfGAaM4g6z5+Mj83yrjIVkHas8QgGYDNByJ
qTSnZ1VN2ISTMO+Z9zNJX6uCoNlQsV0Sg8vzHxyDiImbyHKeLyRDFhrcZHB5mp090NFea6O1rjt/
OxG0Xwd1+3594yS25EyesHF5UkdDQyFvSOaNY3UbomoBuIyjgODDRUdmDVlI9Juer2ggdJmyyS2P
Ub31oiTAZKja2t2+Ck5WgbcVghAAdc5lmHWfWx4K9Ufjxwh2jJvDEJSjgc3BMGIL8LZPGuET5Yor
PSnLSK+O/fzDMD4WVQO5bIeA+/FhDEHMi4zO+a/Xc9ftc88oj+4LSCD95kuaK+p6UgkwtMijImDy
RHrwnI7L1FqYVMt7irw0Xfl2FSzKaXayO8Lt+f+KMYVjqDN0aTWgPzpWxcYqDxp9QWORrrjqMo0F
MgAHDZQA0tqCEFATMa/osvJY+x/FS6/q8JJ+HsU3vABhUeADzw+jyQcXCAoCdfUR74z5Jsdg4+va
Knn+QaH4MHXMGeNgUH5cJwpFjFrzWqqXR49ogd7vwSa8jtkHpXRTaCAzQm1pZCRgE1PsnUwPeO8t
LIyN55kIZMMk6rJpF7s4suXD9N/0+qsx/7m+OEkIBG+CUBGgBGAoxa54K0l7jBFCTO1gIpxemT/c
ONstdvmPVxuBH6t4o2Qr4vcSQ+p1oEVEs2x1eD61bVQcB3TJmqwKtFrfmP5f7BtvM+PJKCSoxdC0
osmQzzWk1MOD5+6GaW2o+q5ldwcjQdFADgwg9EIoEExxrlG3hgfriy/AjWxScFK241M7qqAvkgNC
FgoZAB36B7YaodAxGhZobsmcHLtieh9KfY1AMyCxFjjdsJlG99vN+oAkJWClCGCQE/i8Cye67ted
ObdZmR/9IiTQN/rGDDOY8S+JXq+LklxdIJzBKwTboHPjcH6tsqlA+D3YCDXcb04wGLe7SjSiYPwv
OpQQY4hKEM1L1HQ4lmP+mvarPlZYBYkmo7MQLh9PdlRBxItTWokWkbqqjp2xzqO17a5nFYuPJHGM
VCefo4QFwFmK4R7YE3H4DeJ66vyK3VUx0Z3XFSvMHO3ILva3UUs3VfkUGaoni0S7zwTzv59oQeO4
7eKaETtO2vjYOePancAEVkR3YJdR3FWR1Z8H/ZAFXkTee47Y3DyXRaokrzF9hB1NvVvF9MkzHq3h
kbLvRe9vHO+n47+aKVtHTrfqVbdYEr4hl0ygfnAdGD8i3GI0o/4Pad/aFCnPrf2LqALC8SvQB7XH
U7c6zhdKHYUQEkIIBPj1++p5dr1b0bLL572/3TUlaUKysrLWdSgcFUTyVnp/tbqIyQ48klU4bfJ2
W5j51Kt+seKRkhyDEmoLfrwsLKs2HmUxGtzT5mt0UVIZjagsy7RgPK3916DYeu2qA1HDLWUi2+uY
rJr48ftd94/z9bESjNoS5DewLaDy8blQJtuQea5Rt8NsXTk5NgZabFle0rVbkAPh7rrvyG/09kCd
5QlcyVcDXCgL3Gj4pDnqxiJzKIfeE2mevv9pn0Id7vhHsvbxa4BQvRTWK3g0QPTLbvdmvApInEzO
WqmVV27s4selNgyAYy8+KgwdYWCL2ENGaXqlerknnKcbWbATn/qrV8El7diHQ2H6k9xBMFmTW0Ya
z3eSxp2yUaise+nap7J5/n7SPq2p41TZuHAGx0wBL/Vx+9Ss0mQUntoHKRzeeLn+8eO9o0QLKqtH
fbll7jNS0tZSld2e+nVmjW3qqFOSDZ82Ia60Hmp6R6BccOyPfnwDX7iTA6W5Ye+TNyb2dNzYamOs
29yHOpN34nz7YrogPY73QTqHlu9SitWFY5YiQaP2Qm0t+9y5/vF0AXIGxw6UFgB1WXbaOjjQDV5d
qr0ib8WKiLefPx7tNeDO0MuDMcgiLh/7GxELXLUHlf1Fn0qbvpqb908/Lup3UR+ipEEfUqL2LX9K
A3Ki+vnpwETN5f3TF5m6V+ligGuf2v+pplvrj+nvfz43qLEhpnlHO7TlSoX2HhzA/aDd1+JRiy7t
He/EXvi8UI8kb5z5KD6jkL4M3w3EdiyH4uOW8a9xRPIf7Iz3l4QX07y1ulM43uO3/BCnkevh3Adm
DjdxlJIW28LycPZCI1btTYmiJLwNuFj74V1+inH6+atjHMALARY5KpouExnggeJmKHq1d+iqoSvz
05r68TXePf44/LtFBUOOuhM1Ht93Oyrv4Iz4/Wf/HGnxfFjH4dOiO+ItS97Si6uyyPF8W0fZ2BRX
LRxrHIendiRSRqLD98N9XsUANiFJQQkfg6Ky9PF16riDlO08mj2wn4ljXovwPjA/xSRAxglThgtM
jGsScMofx4B7J0NyXI17E5rMb1Tm/jgIYgBcKTBleP4njkmRd9AGpr3BQk668ldp/fz5aJ1DV/l4
+YLHw+IFMHXtFNnM3+t1F0tgCn+MM4NTHNKE424PYB+0FN+ZOasnNyz9fcz++NWe8jWx16d4H198
auw9bHRUFsAiWyaHoANMSKGot+9uCRkz3fFV+WM1RbzI+zEW1ZFBhxqrDWNQ6mbU3LfkVG/gi6B1
pK2gg3Ls+H26qHpN34P2ixFkmXFyiYNlXYtXezqzvBWzT8FAvpgz3BlB+kJR76jid/z3d7vd7ocG
0B3i7qPZ3jIbbm6JpYvN93vwc2QESBmIHTS5jvDbZWQsSsmFyyJ77zivo8tSM+bpOFAUY/oTadwX
I+FIOV5PjtevTwBsQwHMQUVo2uvJjaFdbdRw4eah+4cZGmfI8PIf5w/gEwI/g+sB7q2fRPSjOZ9w
wGlvX3arbljpU/TifzW9j6cKCq5w1ADVBWETe+fjB1IkzMemgYGMAz+9VWH5dcppHeHiobpfM5/h
+cq5dDisUWWBhM8xZ57xwkTPTnsxOxE7k4LTW0e1OimMohvcssPLHLIcO8In29pMQdBfOTDbuiTj
H0iuAbscbJnj63VtF2YlFMqZ1JahSHK/OtoSh8Vq9G3ruauZc1tVwSl5tsU3RKMH0RrkveOFFtn4
8o1ju+u5gq/tTVlm0klUcENYZsjPOj+fRlls5MqV09z0GMVx/sYzysKnIsViZ30aYHHwqKEeO0Ex
gMrzhIZ3znCrhtX3G2tZcPg3CErnx7swIsUnkfqmc0oVi7G4oWa6YLS59CyyCS1lJdAGuxphoeP4
eZbD3wagn6QT0d2JHwBmCRbgxwV6NCZEnxFpOpbnsmzTKrjYwD2X7OkQ3rtlL35BwEBsR+pVBbC4
7m3e6PaqD1yeYieSjXKnoDkzoLIm8cxHnsajPblpFQftZvR5vWu1fu6i8NlmQPJOAzR7Vt44Bk+z
U9K7ss4tDoRybwnYZIBMk3iGvAQeWH6AU5KzlomQJjE0qLNKWXJlemHBSSMYb8uxH2+tKQ6eGJ/Z
28yLIsktEay1g1UG2483OG2s+7CCWh8FqqttLZai6anSoQhRzY9H54zmsKO2WLmWOlCQ89QowHvX
YkYaRpyyfWWj0+9G6KJeiEijD6Nc+qcU4F8l5TTB7rXUSHvqwlvPCjoPaVv6fxTXPjrlIf2NHRqw
BFIieycy97XpmmwOZ/bA47DJeuoMa7+OyRqxdEwHJ5+3tGZ2EvUOW8ncQkar2R0UlIpdBx/FFemt
53nyIpUMenbLBG4W/M2axjLpA4Rej8ngUk7OXW5sdqektLaOVG4a+X0Io/p6DpysBL+RrPqkctoH
eDDFvw2a+t0q4pW9cWT/xNrhwcHqS5xmci+iGB8gEbFdpErL8bGSTaiSsPFn8NE5v5tkg+qJa8X5
2URIl3K38q5DarwmiZTgdSYEiW683jVokpY8LQo9zMk0ze1FSJrphdrDq1RFt25l90fMKN4nvHL9
MYFZOA/h9Rndwy79fuyiB3eepzIBg9W+0SGDn0oFGTZmTUVmzyLC3w0FhEyDeGxU2luW+BtEgCXW
RV6kQ5eLW4pC8taL1QFUmz++M94UoirdzHTjinb2q3aMSvImGK/ibjY666Leb351VtNvjBJvNcJv
vgaXCQon3eAfAjq0PTy6IYSROZpARboYoi5Ko3Gie8DFfotAC6SNVjCibmtumaJ/nDa8mSotu8Sq
xG/jyJexbHGesdJLYctAYaFZmDT3aJhQCbfqTgbqLLb6gKwohe1kLauSZzaothd6LmmbSNJCbqcg
cOeg+bAKgopumgrO7oOvZQbDQvkm2SjPGON39TQWid0wbyWa4qHvLHIfCLc5m6bubxvobkgCWYhz
WU9W2mv/T1+QOcyskHTRltPZ+Tv4NE8Axh9TpDJ65ULQXN3ghIGIZAulOm56A5VYGGw1lNKsLlDO
Qgv7HhBEW28sSBL15xNMZryr3Aaoau4UXCl83WRjThgShzjIwpq+BVUrsrCrer1qjsZqvu6beh2N
w4yl5LuJa+xdNRFbJN7kte1ZN8F0DrqWThpUpk1hzga5xLrxdqEDnUEbnLkUdW+d2RO7cUvoIWlv
fIZ2drsJal6kJvf8FF4qvll3nfK9tJuiv2S2Or4zTP1ijeK/hBGVi6Wh7lzOd1Nl3dRhI63NPOAQ
TjvPHiCZSw+w1310oipoExhze3PmU/NbQpLOnKuIVjt/UKDm9oINTmJJct8hZ6IpqrvelSQ2CJYs
ZuZO2LwwZ9q3iq3xZbGfIBhjgR3ZS9yqfJEwqyAb5CfQutdc0FVlhX2+wUq9Ysre6JzCMM5lv0Mb
Eh/IeFUGFQ62iqp8BHgR0oUJVY591fLCu1JjjhN4GIZ2NfnmwtgtNp+g0paZGMfoxUVOvB7L3H7J
1bqv1wPIKvBoMlj/EKW4GivPzQFTDAqId9vRpaIupxlrfPUQKTIdgI14hvy9fcH1cC1qfAwh+PS7
9ZsSsYV2ZQo0ttOtZlOPaQ0A5K7woxpWdPb41GuVb8gQ8TvbGu9mUT2CQSjPIrf1d24dkF3UYlFg
D1vp4A95AliqTirLphmaODiXRzGtZyBFdxbDYXBBgmEYE9gcP9dB3MAXBaaF+mAUDO6fPO25GTOj
yXqE+KQuvSADWsLL+qBtgcPU/mzDkqaJE2O8OCFR/cIiiV06wBa7qpohP/OgPVoASe4MUZ5WvtVB
e87i8CzQrTFsPYo5T7Rr4wRyA4NEfIQOJpVJnndb0k+PzVRHWcCh/iDdmV8Us9p1ptSJHmqgkJ36
OUYSCF2y8kqHs5t1gyIreCVEd7YB5tU3A1IAT1qPOCneJo9SO9VN02cR3HtEMg+4wSWit6XckCKn
zibEwceyua5HtpkmwbEwy6JJvFmTMtU9rZNSxCBg+82d202zTEbG84xoOEABNLetQiuda5D8HSEg
gIufaBOOdVQbsmks4q5o6UYp7aPqF8FfJnVfb6SfJ/Avn9Z6wA9DJ6rfg4lhX7uqECnUCbArvaEN
YaEOSfqkrbW4h5ZyvZaT7a58yvKs9tTEsxzAoRRp05T49TwkBM4HO6DEi009zmUSafM2YS5TnLEy
jdCovw4gcbI5th4yHhOzIp4ZenyF3Dy2NeQbbae6BkwvXwmr0o+IfOYRxn1ThqDcnDdR2d1GkjcI
B6HXpnlo2KVbT/NvWtYN+WX1jvkDQXY3mZWCf6dwmrTUTv6oFH9xusBfBwgDic2oC19tFy52Vs/O
gg7zEYf9X4/oW9s49670WuDerGgfyYqso74MVEpHYH0IWqeovAb51iGqy3IJV3nI6VJYMMXubioD
SBsGojsbbNWnbe1iAcU9NzeetOnWZ1AUYi62Re82MFXiyM43hnn9JneZuYjjvEiicoxc3D41rBAj
0f6CwoL3SIbqQbtReW901ST+GLUXdYGEzK0q8FHhN3gmwxZbZkQidx3NbSxX1jCSpKiI+NtpO8zw
O53E67qaJ1Nu/y1qwA6yQdoHT4/duLWCgemrwXPKl85F4jIQda5i90Z7nO5a2DDxM6+vGEscbx5U
OjdqZ9PwlgVwuhNQLk0CXz0Wkb6WVdtsrZjT1GXlBtlZ5I+QAB7XVZlvVNcPZyywvMyxxuAM6pA6
BfuiTZQ9uMOaNpBnVM58BGTigCYT71JXQCCj9/llMZNilXulWo2WM+AvuiwunlQX8rRvLbXC8oDO
VUAyKmWVjHE0b3C4vpHJeTYSlt5hIUCWQaOQxRuvirI29/8WRNjJzHJwjsBYTkJFQWmrOIrttEzi
yuAlAqlTVMoxyxBnTj2HFYk05SsY3/V6lKxDb7Z7IKylae0Gj/Pk03Om/StDXEjiRfKNNyK6rAq7
/wtKnr2jUd4f5ijPNw78wG98y1R3otDNiuf2tC1kYOLV5NV29QsuJW1i8bi4sNt4hhg01Bei0DS4
Wqve1wlpLKRbDIynVWwmQO0jHGG+6BskbJb00XAX1W854XxL7JaUew9S2VNq0ZY89SZUjy7r/kBz
+skUQZ7yueyQqlWPZWQO+dSMt63SgNCViDA7u9ODzGoW1DZiqxlVGuEU+jtGc7SB7P7whDRBZajI
+gn3KPqtlVbtqiysduXn9bSKmVtdQMdDXbnc2NedDui6DaSPTxEwllZFx2MY3035HdMSyOXc7epw
p/uwcZPCG+Y5K0LLXVuu/ZaXeoAbjbhTQcBXiLy4LNi03ToiyCH51AAXOVi8eKKd0MhKVaAwO11c
bhoEpNQAnvTHs1RzgYsCtApnqxzNTni8dQ+1DITYQq+YynWAbBY2BXm1ZnXLMkbLA1r/fxuGvK7x
q5T4/ZSpvMcNIp7f4njQiOI+ok2IX8/w+VecRewBwNNoN0u3Wo0V+B4T9vReBzNy9qbVf6jr64Pl
WVetGoDmjEONy8/Up6Jrubdqag5ZTVE6B6BnIr1xpopWedKIobAu3ImLEgYggxX3SEfRdNR92yJJ
nMW6MDZogL0VPA74QI95HfvFL1+jXRQCaLu1YSbkncnBuQSmYoD+6kCalHu9va0rn/SrMlKo3RYT
+qwgqniXbUAjsDDrF7fykcBCYvTSiamBhq8pz4cCQMLEQZH53uqb4oySvDCZdKHNg8se9OBAemrO
45Yj6MialQ9jUESJFdaYBwAQIRkoG7CtHAL7V9d+CvyZ2eDdIOn1Rtgq6U4mnSpbwMFnmrKiOtjO
RNNKiT239V2D5t+5F0vkdAWKClMcdWlecn7V2FykI2ovDyIQ17MskX3ZfZgGvY1dXTblmYMTY0Md
GW0gXeNiMxNYSUslziHbaqtbcPjcJPLyVvwqTNnyS2jz3OrA/mODRdHv8kJ70U1u2xBVm+2+TvK2
fuF+f7BJfee2ysd69YaH0vblXVR3jkwsd5ofpNePl0OrdhEvggw4WYZVH0d/Bjo/eNGzKAVOQWnZ
2wJWe38qUdkJ6mGgtdCwdcs1DQ2/zaF+9RAU+PVe04TPw9xHSe+RG8jS+6tpkvdN1dNUVNgXPOpe
uyEqsMuaB8+MInVm3P/KsW2SsLX8TRvUIu0IqH39GNsHJLt3ZeTRB3gzhE/QKizPZ99pcYR2YZ3U
Y95c5o079mlT49Zag3C2qoEk2vXQmLPXzlzkt00kYpHNSgu5nb3+thMBMzvKjuq7dYCLXBmDqtqb
/NUZplem+4uhrSB1H/CnKZz3DeoWcJDy5cB/9WX0QnLhgdLf22Y1F6bGRcx2ekhyRgD7RaGAnmUE
hTugPHSDDw5fCfcs1k0IkqDXnvmN/WyP/rMX91XaCARIn9vPbgfutYtQlMwUk4EmNQdcZCwxZ22u
72eA5dIpcnLsoHp4az148tV+WKSTCucaNYay2Gkx9OeSWD1JmJG7fC4scJR94N0qd/CdjBXBwyhB
F3LodD3WQZjhOo/rnaEVAkt8UHb+YElqJaFfe5uZ1jKdZlJvZxOV66bKe/w02t4ERgy4t0sHpKq8
Un8gtqEzOiPBxp00T/tgMjvgoPEOBhxjNtfDwTJz/cRiKX6D4yyGLbT21FUFVkXi4ugZUhN6+xkK
eXctFFm2IQqUVeqWNttBQtG/k6yg2OGBgnd3Zwd1gpSRPErAes9gDmf6LG+ssF2LhgebAVadvhT2
Ay7BJuNAY14i8e5XHW86MIyI81Q3up+2QwFhBlyYgGQuEClwCsZJrO027aJ43sgx+o2pzxNkJaCJ
RchVp9k+NLVntozixh8O29Jx1jHV8bmt4A9X1TntL7VmytvFTT+vep+657SLVApEiso8o+/R+SDb
wHIf47Idk7GJ78oBL0aYnwSlv8sre29yjRycFS9hJx8NYeFqLkl8ZhQufTEAPWPIzF4WpdYrpew6
VbZRdWrZtshaktNMRbjO6Cl/DiHVl/pWDW1Sr97y2t26bbBtrImrFFlym4TBvGqRXsVBvSXqd0S2
GobezuS/wm9PrbtWOhekLIG+Rkfl1Ue146kMNe7cwi56+A5CLHuqxRXul/duV7AVGwYk3LKr1iYO
u4T1Xb1DCXpPp9Z+nCwqLziHD1tmcvnkWLPZIK7SrSrn4DL3PHPDchlnVe/5mR1WB67nl6po/A2j
kQCZ03Xr3YDG/V01981TDHuAwxCP97LVNrQCVY4qW02HjGFbpEw78VlbWzyrIMbWJKicey/UCP8R
57FptnNVvaDNFl7UQO/9okXQZqMZh8RGjLmYI+leaYd7qM9wy04GL4cUd2T9jl1z7c2zs1HCM6um
0nRnXKiF52CbJrQXb1FpvSq/QVyIqn3IoGEokS/DndF+znMBFeUcgMZ8puFZ4fMgOB+hUXjvzahx
VcRETgpVcChxjbjDDoWKotQvHH3lqWqGFIovkQvEVonaKYpcvTPILekqeUdFgfHK8GGI3SEb6si5
NYbIV9q38ErKET2hCzLPvyWOhI0muNWuR9wEb1RwzP6DQMqXjjBII3ftrXK0C8Fx/IxUV6XRuDiJ
g2DBeI6TFo35Ka7H3VDTcD0O8nksGAJSMJj+pu/c9jcUsmbouSq+KpQVX5aitRFvQFirQKIOE5Xz
EbXB+A9u/lVaaN49zMCZXgWjWxRpFOUzXgvpynngttRGTTUP1yafYI/YVzDQcKP7qVP0NUaZ8xrS
cQ/AQQbb2Z1IWnJc7VJTTt5qzoMHB3W6ekZgDeBXAfnQkr30ytX49fD+TKQ3VDQz0ppuGenYa3iE
KNHcIAjGBfmjcd+8sOao/Zv3x89ue9f43V02KnRKUtjO88yN+2EFkGJ7yGPcZZ0hvnWHMk8HrwkT
BD1sRsFNUnvUS0cEnbX2muKpAjzqtpI+eY08Hj4ATlv1iXHp8WZhMQ+riIwjoivuv0Saaks7C8BU
EBOAQ5IoPp3PBA0Wz+bTNRjB0S/PwBVw4r7YHGPErVYmnrPKFlFSxxb8Cf0ZAOeCQPncAWosSFuH
sPX3Nf9FYwNYL8R1WMgem5MgrS0Rp1J6DlKqiezD4WEOVwPZNubn/WgINAFZBKkeYJi8RXOGhRGS
Cs4IGuqZU22LU8ILX0AooIUB5RMANfHfEqfpoz5Fyg5NNW6tOj91Tmlpf/H8IwIEMC9QlmAdv2Ac
cGbnMeviaK/9Z0RPrL8ff4L3z1+isoMuNCiq4fm1HFAd2nrirEB17ftBTrzE0vbeUcUUocATAWey
wwlinWgKf/V4AKLgjwHMLziux39/13l2UdeBT1IQooVy/lqcshP5/HQoeoJSApxaBMGnJbU1mmJi
EdqTPVCi1ln0Q/9T7IGPj190ZXFz89yuxONtuYvDs2E+M9MmRCnip5/g4zCLfYA6JFoaliZ7Mb/M
44E+//89ftGidGUnC2A9yF7qLYrX5MQXXjRy/zNJQBeA4w0kQ+AvkI7QNBQBRejbC3sdwSpYJt5r
c0pe+asPDZYKbLZi3A4/yZTl0imZrABd4SMOxKlJRPtffISjKM9R4feoa3l8zXcLlVYdGuhQ+d57
qD5Sb8WbE6zWL1/h3QDHDuu7AYKqmSsJacB9T4bERFlun2JxfDUC6Dzw1SGQJcDLfBzBageCMpPr
7e8ljF+D/BTD6qvnQ7ro6M93JNwsyRUmjhglsg/2BscgkvXQWCc+wnEOPnaZgeoBaAwgC/B5Phlj
oCOBFqmnw/1gLucig8KM2ajbWPx8R3wYZoF5tHjFijjCMBINgqyofw5PweFp++DpgYAAoNXH79A2
qHSUZRMiN/Z/sTHz+cZDN1ih/vL9zv58RgNxA6QLSBoAj4MN9XEgHThk4DLGtcKb6W7yxb4lxr+S
/eCdGOmLTQ6WNPhcHjIvqOUcf8m7xRvDP8QOZkX2EXZHXB8m103GeYOazPdv9Jl2cKRjYyh0aBDV
gfL5ONDIQPHrqUf26C4mxFz30BBBiWLqUG1Av7IYd32/cfkZknoUDU8sv8+UMoAIASkKEGrA63G8
xR4lxyqCiOx871x1oQ9JaYAH/Bfp3cW0SS2ZOj3qJifEtD7vKgCLAKoALwoDf/KVz/ugicJR5vuy
KDa5Za1vvp/SL54PLQCgbI4OctBEXMxoONmmDnJJD21jLoXDz4lzQqny1AiL0NlwHXfQJKWHHu0x
vbKCH2NVkcYB7HcE/UFPNVp8FebDxasnjB6qCnE/Pckc/fL3w6QgwIoDgHHJhYx72ds1hBz3Dm5o
Id+4+r/5BO8GWOzTLh89ObUYQNrr7mC7Jzbn59+PFBSdAACgoZvwSVzTHnROGpQ69iCMMgk17B+f
XHg+vgB0no+XgSUBhDmFpRuTW3seXghnY6IT2+5zGANC+N+2OwoYf4r6rqVhXOL47BDNZyI+VMFa
TOc/3QQfh1hEfDG2vg0QAzv4VgbSHC9+vInjf8xmsCeRpXzaZAXUtpkvYJfo2Wf8vCl+vANiJwB2
F8BjcPM+wQMHU9aGz1Z1EC8lEOfDzxcQtBGAREWAQOwLF7PDWu7ydorZgZS4tSbNw88n//3jF+eh
O6hAhwMez8VF1P9S4Ymf/zlrOEo7/L+fv/Td9tASYoOH5zt9KkO0mN0EtVZG0TeNTglcfrFWcRcG
IB9QuKN222Irj1UQlHXMxSEM7pp+SEYY8p0ipH0+bI/SyP83xnG/vztsW95BDAgAsIO1koYmw8o5
1qFWP/4oHwZZHAtRICBYkWOQhsDqr7qYxc+3BO4GONpAa4O8yjKqtq2fj10lxAEBfTV703le95v/
4h3eDbH4GKbLA5HntTjcd9OvsfrxsRYfmRfA5Do+Dp8l3p/VgxoLdOv2nD3rJiXuiVzni7AN1iHw
8jE+N+Cdi89cN8BzjE0e7Ec7o2dANvx4cj48fvGBmQWONCgYwX6g4xridQ2bTuy7L18AEr+Qz0He
AjT2x3VauzSYh9lgghQAaiFMmMyJEY6/8eN9ANqcOBSAD4aQB8o4H0eo8s5BZS0K90atAUsK2Dof
1t9P0xebDWY0uDWhkPNvV38cogEmw23QrdpDjDn1qsvGupCFSusf+25AxhQ1qCCEmh+kepZJjASc
m0LSNNoXlbzIz/nJLOmLKPhhgEUQL92yVBM6r3v2BhyYpmufpmENivCJTbdMksGBQWcfemu48R+h
6ktG1+B4eSdhGn3QIfIxFw1j99zq70PQSfr+bI6nDFgdVJfL7fdf6h+z491qOJJ7gPjH5QB1GXAM
lvU8oSlxinwkh2kETgBsXOYlBZrZd/E8kQ2FJTrq0M091b55zbnbv5omiC+ENPkbjwN+LnL7XsLI
Zc3dPE4sMrtozQ1AExELVwvddtBVmeoyui11C++93i2voCxteEJhEZHy84GkYP6YtkBPebyzIoFe
s+xWMVXxBh1tuXF6AkQfAGRnHYAHsKRhI3DGPGb1DvjA8tbE/gFsXjv7fmIWu+R/4eGIs7i04H+W
4upaRxQ9Gbu4qcs+KyjZdOGVnH5/P8hin3waZBGtQgCiicOd4sadBAB/MMacUCexbqwf6v7+ZyCU
U6Ey60P9cMlS6n0TA00QlzeAAzyXtPkbBICDxsOJnHz5Pv8WE0HdEHxgqAUsJ61w44GX4UAO1L/4
vWnEjp2YsEV0/M9q9aAqDGuaL3K2uut0bNs9OdhDkQFargb3xHc/NYL7MXR18FR3vRKvAAcZa5P/
Fy/gQqzaBykdkhPoBXx8fClQTWo6B4/3rA2tyu2JpJZ88QlAPgXD2APj1/7EkSaGopwUteQAwz6o
/OaMXRahI+8c3RTXtg9NM8uf4VHV5NV/oH4+k/4vtGTR1BlM2K1D0vvn0mXBLe8avQErxn0LjPmV
AzS2tV0TAUZsVVlbWfIsnjtnAzAmEPBhjxza6YAlizq5HjRgRQMA9hvHK8d0ouB3pmh3d4lkvf23
heR40uehtZ6nkVwAm3NKiPgYmN+HtSMT5uj1hH4gfB4AHfk4z44YTUMFKW8qSJQlfTlAxA2db+rs
ZW1QPyJvrUNPLJ2vxvRg7oHPCiEjlFw+jolA0cBdqypv4uA59rcVPXB67qk4aeMuMeEpO6ivIhQY
dZDyhh8DPF4WuUjXADRemLaEw/iZo+D1fY+p/D4+LTfDcRa9Y7aJjReBALpIRphjWtzyouIG4OTI
2YvqZxSwY1gKkelgumBbfzzIP86YcMp5igE1uW5BeHG8g9v/LB38NwCu8EfXaPST0C75OEAtRG+5
nRdfc7Oy1+EpEtEX8wMBGdQJIZCFdM0/roh3lwonkuHkFH58XQ+Xu8H/L348dALQi4EtjftJFHe0
iXDsJoyvYWTV+A+G/zBaY/YjCIFAqxZMMYSjxXqtAqsiU2mKm85P8uqFBKkbgxLysyrB8RN8GOU4
h+/mqIhHKkwx4CCtxQYox6dQsZ9dKv53CNDHcc9GFX1pjTzYOY4dgBpugmnaAMxxocBP+H4nLMPq
f97i/4ZYzBUvINM4jxiicM+JlUXgM4iNPlW2/GJLHxUn0dCAlg8kOxapeUwG2Q4QdLiulZ9MBLp0
Z+3++xf5YsmirIU8ACcQdsTSxt2Jcj0riEZca516agvIwPfP/2Ki4NCEviHuSSh8LLuH3KYRm7SN
Hde82pYBJutcDm5qfqjdh2+OVQWNMgfiE5ioaLH1xjryC0Db4+v5RbOr+r4ffrj7kMsgK8cx6iB2
INlYhFdWQVKjDEbvQNy3+Kkg99/P0/JT4/FIASBCDfI4HI+WtzCp8yjmUU4OaM4kHqBb43gO9sz3
g/xz5Xl/DP4bBS8Ahn3kA3KweAk+h3pkceEdwinMmv8h7cp6JMWV7i9CMpuBV8i1Vqp6qep+Qb0N
i9kXA/7133FdfXcynShR9p2HGalbQ6TtsB2OOHFOvo+6d2/P0eJqfQegGa0yZrVhf2RXEN0U82+q
v1DnO0fFUeMrmYuLfsuPnwK2TTB7OUjEqAlPw+siUG5X8pCvHtsm345WEuq1AEwWWpaJeDIjoEVB
X2VW+taoqhs3sGpeieuAzhyGLIV53gGOznx0PWr1fWyJlbzrxThRw5PMEgYoMiW1pErOLbrBsyPE
f09oqH7WQP1Ga7yhxprtzLzJtmPGnhs3fZ+0rd6xkFhrUYgha8Onaw4q//+wp6GvGo3AaojJRhOp
cTQgPxuD6B+rwdMDQyNAXVf156Ih+SPipuqYZMySPc/GEb7TA+2OGI6hNGiTw+DmcRBz7x/RZ9Bs
KeIaoOsJBFUtHw/oDFpLeXw8C9RfbAG1Ip1jQQaDtJxNUBxInrtes7fppDevaTvNG555SFGgyfpp
rvVy07Wl42cJRZnXHHc1WgdIzX+n5cBu9BUc9tgqcu6QkdQvVFLMjORtXuTpyxgb5bEeWf/o6Kkd
5AMaOkRK1wrxyplpEZwEYHiwpEHw66kXMcJX2hvaAJRo1AUmfZzLL533JbKq4PpxoJz90g4qAqCg
BcOi3A/KaUCMPuEaYKIvlRsUNJjXUt7KmXbxfTnOk6te1E6fTCW+D7p44e68aevdmAD9jwnUTMHl
AQwS8mTnJiY7Kxn6YNOXpHc2eAz6yRrv8NIgsHeRFUFSCXl7JWQsaE0SIGDTl8a9T7M90PisWIlX
1kwodxcw/wzyYUX6wofAqAIGcoI1GZSlpT4dhfLOnIE4RasZRkG7XV9si3pli6x8Xy0PVNitZkWx
Raz8H7DIgz7zeN1XV+ZIpTKYnJm2XowBzOkbrf/hbRus1vjWbCh3gtvUeMnlsDE0AZn3OfoP1uJG
fWFvg3YGWw5cxhZI2ORvONkTczYntdZoyYtTAS2r18HEDg19zMrjEH0pTOBGzaPhfR+SPwP9rXl/
yvSQDDvWdru/mc9/f4eyNxFaoj1bj5IXdDcOxs5NNnQt67s0nQiUPBeVI1T81eyPFvFxrvssfXHH
jQlUefSpzVbypGsmlO3vtJwDKpakLxVWLD4O/UGrVy7wpQU7HYWyYFFideghhonUedeLrYYuoiag
9spAlvbPqRVlOXAboABcxJiraNuNh4b8xXKjeo3XO4A/QPIp75UUapBZDKQmtKKPiDrqct+tUXYu
DuHEhLIWZub2vMsNeDZaDMrALQ/XPXbx+6gHAh6DFzaaUs93TqfprOlTmrzEELohQbfGW7i40Cff
V36/B9RVxRN8f/CekH3Oyic39ef0bxbixIriTuVQ2mkb2ZBRz3fom2M48d2VKH9tIPLvT46YEQQA
aId1sBDveJcCBe9ld+W4YkReGCcx2sfFKxVV/n81lGtxdPNS9CVmCwwlYGgA3LzWfNf+MVjbwXmh
JMyr1/9t/ZVb0p4SHW0cmLlp3kXONls7mtf8S7kiOfqROgpk/8tkBq4Z0huzEuqMqRhOLQUAOHXw
/bbyuz/52kNj5efbSq7A7DMHXatYEGH4zTv9+T9Nvq1cjQbrTRdnbfLS93d2s+NrKLtFnwVlqA5y
eVQK1CirH0FTMyP79MJEYDf7In1KB7803/5iFCdWFBeaxsQZjRanIENrSHGIvM317y9eRyffV1yo
A7qkih2SvHTiyMOsOE5rMiEr86TGWUNlRFY3YgQjuXNFUKGhbvxTR+83jwOUiADbOHgWAPOk+FLT
M+jsTHH80ld+MwWgMZj62/BOcjdIMCVAc1IFAWoC54fUzPvUqpNBCxNwOnnO74ZMu+uDWJgqJDlg
CJ8Hmla98giajhjeP1AjGc3NzO49dBSNhwL0DdftyF+qnIRndpR7Qzc1l5fodQpzDW18JNC8F8Or
NhTw4Kn5bqxBnOXBes2ccoEYbjwZyOBEITHfiyyMkv1cfGPWA3K3K8/DS29GDhvNEXiJg4XzQnMq
ApskeEwiEqJNiILRpXzq10SbLg8taQKdKSDaRaOYSitKY7waRqS1w9IInNja9slahLhiQeUIFm6e
dcWHhfQbiMnGG+Vm4Vwu3MsBnhUZHkDaleXQ+zbVynLSwzmmu4HZr3UxH7RqTX/tctVhxpJ7Btx/
EGNQdmSd2UQINOWFFS0PUQFun7b+rUfNdpzpc9MNK3tnaemxJ1GGkZiNi64eUELNxQzeibDQ+J2k
IHLBpEDIr1t3jivZaoG3Q7MB4KfK3Nlmg1xuglihTab7rBlfOweNmAIdGmNk35dCfHITZ6WEdXkq
wCYqA3Kt8DBRsWVJAjKDbMxJSIoa9DEMvck4fcxmPLRAv64cDUvOh4Su6yC3ArZt9Qgy836O53Yg
YTl9jYpvBWqq12dwaZ1ODShnT5Wi5CRSGHDn/Uj5JtUCkENt/sYIUmCozQH8oILMDDcrBEWdPZwt
dMiKPhDaq7WmYbg8Vf8aUaJ7ZppQ6KsSPfS6Yy+eEUxeH8TK9x1lA2Ul1cCuh8Oso9wH2VU9/40B
4JvQ9ACIMzRUzy80m6I7PMWChEwymv6Cys9fHMfom5FaL0jpIpmsGHCMBhVem4RJmlIf+kR0jwpk
s6m4SVe2/+JkQd8OqDy0k11EY2BQqnWuYTEs2m36aA5s829m68SCcv2jxmzEUrwmbEn9KcmqT4Az
rXXdfYD7zq9K7HUPQliSlhWUS8qMgeBrZFrvYMYo6slWhts4IQ9N033RErBogDAhiNvuTyUaUD0l
6YHT6oAuKL/LIDHS1NvrHrh08kCCGGqm6EWAPIfigUY6cDJM3AhBJdJ81fSw08NG/MXKoTyMwA1F
N3LBDkzm2eEDyg1hZiYFtJXtYtPUaCW/PpQl/wCUH50UeAGi71DxdeahgEs6oocpuBrizwh//kcD
yly5dcQ5rg49dLKHdLr/m716+vuN863UWnbM2lnoIUjCxmRzIxb7IyY4/bzidw2UXXhF8HnNOYBB
rSIrz5hFTwL1N1iNDSQS1VrhUE8lKwZLD2sr6Jt95z17+oNxe0rKBXrlXyvKJEVN4RGjNHEiN9lG
H9LNP9edSG1D+pgmDABsxqbUwlODv0SzM8R/KQnT4s0GmoSyfWKHifFkpNVDK8Da1Efox5+CSjzz
cSXnvuTCUHWw0FJMoQmrVkKrXkDaoXFF6LrlJo3LzeH66JYCNtmpiTY+tPNdUO/GrKrqXBciZIAf
pz7wqi2oJNjwdUKwuOMGKY+2OfOVV9WSZ+C4hoIdmB8QuSsP0DLTh24ApUo4ohffB4mjeLQ7gwdV
bw931EHl7Pool+yhoQHSrhTgYZSvzzdSOrPEBJEoblWd7ovePXTlMae7LFqZzaXVOrWj+OI8k8Ku
QIKBcUXvgrWHtpq/Xh/K0oK5qIZhsRyAttRgFJ1DVHj6LELwY+3tJHu0CajgLD495gYK0iS/Pd+I
KTsxKOf2JE2XJ3qWuAQGy+7d5ncVuu3q+TO3bgRFf2wz4P9sjAqgKmAAz+00hhY1I3S0QrSPBYMX
ELFWS19aHXSey25CgneiqmZlirlGIDoj5weGRbveJ/rtlUQENrIvSvKDo+NB8eu0TtPYFtKvxzqI
zLCmup+xn9c9YCGYPjWi3mpz3rdOlsBINUIIF++VLdhwBx/18N3fGMLrA0eDrHMr7x7wfEeskM8C
rz902u+ov2/Hz9dNLCwJbmbUXQC+hd4LUeIrsGykqQM0cVhY77H3BwX8699f2Ph48ILgBQ9fNKyq
G7/SgRrSNEOEGcAb3Ttv9iwB49v8et3MwpIgXJLq4+iJxXWn+C5vGhAia5oIU7Dh9M/0vbZXIIeL
FqAtB7S7a8jA6Xx3dG1sQ3rXEiF0kbZpAcmvKdo27RrOd8mMRCtDcQIAJVwK52ZqvbXcGTQ2odAe
iegCR2RBW6+8bRcWXXZXAAQFeQggEBW/qkB6avYCdxrIvMj8lP+5fTFM9MehfgSi/gvQONU8Fidu
hm1eJzut5SHaor9AtGrlrF+cKlxfFHBd2Sas7PV5dDR3Gka4Fjf2s8Z3rO5B/8nWAEjyzlBeB+h2
sQF1RKeIh5bI8yVxWjDt0DLG+QtiTrASanNg5unR6vod60xQwQKNXcb6EbrMD2Vb/WoBWfKHLP50
fVYX7h38DHggZhQvR/XKnmgyQ1Y5E8CMTrsxT540u/g6ZPTNjBKUUtZaDFQ8krwOJJIF9zVAechX
KQ7PJ4tEOYjMQ3vMwFVU69nvofX4IUW4BxLWiW8Bwc2DiWr5ezsAB1ZFFrjdKgfEzddHvnSGIKOF
ziwc62gQUBYABE0t0eQviUFO3IL2d468AFw1gbOGK1bbaf4zaBO9NMC8SUCWsjNmu0iaLrdFaNBq
eExi9sbQjgJ2STYkexANV0+5ZlKwkFld0EdAFA2a8xdPXmx8PKkh9gf0rnqWgcESfZODLsKpS7am
W7/0prOCrV2c0RMT8oA4CSnKEa2AnWmKECkBn06PoLvatBB4y9BsdX3tlo4a+fwALAod/MBDnltK
wOEfgRdWQKcvgG4GqENv/z6CI6wWNgYgsIpvsFEgaSjmORyBB3xyyEqcLK8/de9jvxGckkjPXdQG
vAxvZG6AwU/P64Ntfk9zsm30TxAyCKb4Vb+xD+bD/XCayXmCth/6085nyxBO4pVRO4f3hvO2C7T4
7fpsLa07+lxsHCCoyIIQ4/z7A5gM+5L1c9iD4GlDkydhPKU3yuHJQUj+KNwwOEFkAvXcCB5xk9Pw
2Q7BaxmhveDL9TEseBQ+j70pr3rEYeocWfFANdbbYVl8L+1jivLJdQMLa35mQAmJSrPT2ryEARwF
kM5oMQq+8dzPhg0x2bgJuBFvrltcHJKNcqaMLVDalDfQyXZMmDvOJM1t5Le3abwvVq77hYsSGTTZ
Co9xAeiuzFg/8rbs2t4Jq9hPsU9eyuwvBnBqQZkyxmtOO7tzoMvxm6FwlprOyqKsjUG57Ic0NjoM
wgmHaKvrWwKpyJW9sWxBkjegoxKpeLlIJ4tgRqZdSQBymHR3SM1W7AG04NfXeWH7YSH+NSF/wokJ
DTx9c4fMG9L8nl+AU5QEFvtefrluZcmbTq3IX3FixYbuumgFBpKSg5PvjTVkinQX5UxEl/hHj7Es
aKkCix6tygn0905oJz9odedO+zr9YX1rxe1YQVSWUNlBokKWftS0rF4OQLqXlROK/Fun/fHq25MS
Z99XVrxuBp3ivHXCyAWpIdl2ALZG1u96je9iecL+HYey7D3EJFLOMY5R33PrECUbC73TP71he33h
F90LdwcE5dClcUFMgZ5nbUbCh4aa/TPXQK76zKwg+xvvOjGinFVNNBil5UY0JL37lhTGwYmGH9fH
Iefj0sH+HYd57sDZDLJSc9RoiGfYt4azXVzy2Z+i6XDdztJGwW0IjisbGGowXZ3bgRBi7mLN3VCr
/LnZxNHm+vcXxoEmL+S80EAmZbWUM6sRXqpPM6eh7u3t4jj8duLbR4DSJDALskiJbhDlqjWsjvcj
SJrCIb/rfqXpikMtDQAds2glA8xcMgaeTxBtiFd23MZNWHNQvjdB0j6Yay3Gl6sAmhzZXYyzBI3G
6hjAdI9unSkzwg79nqbv3Si3h3AE6We04YA8Ar3+FxgVQe24QpMAyihQWgDMY1sZbB8ndCWkvtzk
MENBvuCA3RKZQcWZ3NTuqlbXjHCegIXRdtR5KfSHnu0N8uW6W11u83NLyrGV9JRA+QaWtOmT19wV
AM3rALaCO/m6HXlpn2/DczvSO07ukZpmWlHlnhHqdAws83lowOnah5NZbtr2ob8dsQTaLWAXZKc5
vFndLa7XWnHOHCN0nBhekPggrOeO7hvi9fq4lhzuxJCaYqnmOnehj2Hg2De20/C9BSjxuoUlX0C1
HSewzLFfbEuI0ZZgh2rssC6ajbBYBoGO8Wfds13K2U9DjO/X7S2MCBgspG7lK0XCZM5XSmviiA/6
NIXO6PzOKY4a50b+FbmLcMZIVgMCVO3Fwxjc/FaX5dYUZvZrsrOSlTW5PGnweY+g0RapW6DfFF+D
6lZtJDE+77yx4aFNHvMbeT3/M4ATC2pU5AwQvgPzb4jOdtBCfJrXgrulRQBjljzn8R+cZ+eLAEJr
6EIb5Rxm6RxArM7n8ZqA4tIsnZpQLpQidulUNTBhInLsBdTRQCqyRvOykPhB6kG2oCE/iH47NQcS
V7Np8AHehI43MwpKEzxvexrvQXCP7WjP24FuwAJxswujvgbNaEDw8Gg0lKsm5m3B2r5HqtsYA7cb
NuNfTB4sIJGOsjeQWOomiay5AyVIBYxN/BMku8DcbTjbXx/FQv4ISsFI3rqIJmQ/nXHuBHlugliJ
o1ZT14+zPe9Y1PmkpD7Jj/HwGFd3OS+OdXVzIAurqHcgfY/+owtsmezTTiYDSfaOeUEi+K+xsbak
tL5bdE28fcEFMX2o4HywRCAbfj5AI7ULnQwVkq7eoeR/Rv1JS75en8SFjXRmQtmpGQN7Hh6RyLf2
GsS/5seuY8e/MIEaF7IUaAdGou18FI1W6A3TUuQ2Mw6xg6p/Msi4YmPh+kRgaaGLHYiSJcaO0RRT
h2Foo7crvPy5aNwASmLf8wbyoHrO/bRrVo7RxalD8QBpEbQOXWxdpmV45pdYHbOPfRsZyt/X521h
9eFMSBzJXlw8JZQzrqIuT2kdSWL0RwLy0anKfJ7eXHFHtAzcC96wOuCk6kE6RpPLuhgpvVxoUBQV
QbH2UFqYpjMLyjk6d2Dv4zosYEXcb0OxcpbJ/10JnAC89NBDg5SObGY/964arU5Ga2t9mNjNXVWk
FuQ8QZLcz09NZjy5cUN9plsgMlpL9CyNC52gyIXKPmI8zs8NN1PSVlCDHRBCjUEHovzxdmwScBB4
UMiucOhlq6kkM6KzNczJEGr96Nvdw6ztp9E3ve11P1u6g2AHdDQWgg0ACpVouiIaQBEa7Jj1eByq
HenoI9EObX9HXXHQ+2TDynIfuwLNot+v25arc7F6iNtw0X4QwilnA+pVAjKObAjL9IsmGJp37+YB
yLb8dnAU5vLEkHJXzGYvE+b5EApqZgFIErMcTFfXB7PkEeABwT8Az19CZ1AeSp0MzDVhkb9pEDVb
Y5tdmiyEnFAiRsgDwLEyWbkBHuCaocTXFO6ux1mqD/Roxi4kDFeOtoWYGuB8FIGQ5ndB26Ds2Tgm
9lgUJQ/H7hUyQOBW/RFrKF5E8S6tv12ftaVjDo8QYHHx+pU4gvN9ZFkFtSAcNoSQQDrQCXyDRVb9
hvDLSriwcEWgdPGvHcUDRMf1cbCyIYSyatw9tr/M7/1YPTa//sILkKgDOzXY2hC8K8d2X2VFbtZT
HzK+6X2rWdmtS9OF1mqKUuEHe5JS4xlZWvCy64ZwmPNwQm9i1LSvjrvWZrDky0B1wM0Izh7kbc5X
hQKoYEAOGfsFqr5/Yn0Nvrx0bIM4EQRMcGYUWNVVr9JcH9NoCEkZVtk/kO5CAA9xaSjUudl3p9xd
d7KlrQNXRp0c6U3wACnDcTWzlcKrQxh1YO5LvrX1r0KgcLyWLvj4kHqgnRqS83ryjvdG1LYheAVD
xROEbDZWOT0IER1MWn9pzMEnMaRvGIj4MqcMrPx3BlkyUPOv+OACig/kMaCdktkwSVmgXE4dqV3R
E1xOpdFAia5/HNMSVVwStDYFGL3f9EXxRiBD1XEI+AA2ekhd8/NfzDnOKhRDEMJcPMzrUffaasCG
MwbLL/KDy18c572K3M11Ox8nxMWcexKXAOgW8rGKL3Ga25MW4QSxIacC4tL7ap4+1yNHN2oLbpsZ
rCmZtUnLN7ePf05DD54maA0ZooTIFMR9IdRpVNPT4KKkqbN9bebPTqFvO7LG7LC0dYH7QesGqJI9
vCDOfWMoY5TcU0xIDr2q5oGhI99ltwPLwHkOUQpZfELgoEJnkMX1bIA259Aij6Cs1n9cn+yFcwFp
I5RtACoDAZEaL1aJEQ9WbUxhKmni3mxovP2FARxvuEQB0aSOnMSTDSTGxIjsEr+/knLayIcBMnnd
wsLRAzoz1HzBgIgUi4opLAiLa9KMU6jloLV0oc3avPTzL9P+nEDQar53b2RzktmQM4PycDoZEgQX
PeZGeOM32oPWQeWweL8+osVFAR8VUnlow76A1KPGCRapmEyhbW1bD/LYK8fJguPiFQpUMyJdIJgc
ZQCN1drz5FEexo7nP7nGl0RfqZouBBywAM8FzRze1apwBBQh3cppCA/NNnvXhLfrRS9FfD2Eah2U
ce01StWFC+HU4Edu4WRNLCtlfdrqPHRyAqFFcOymQZ1+Iv3NSDb5gP/vwD5i7xM7U8Wcrs1hh7ne
I5nduzYZPidgzLnuAWvDUYKbFvyPZTkKrBC0gQfjibafS/5tcrbXzSw5GigAgYhygF/EgXvuyQZt
En3oEIFCY01A16/7fP37S44GwDPK8hK+6KpMgJUYs7pJhim0Zu53ULUFRHLqVgLOpUEAxoZHr5Q8
ICoRHbXA9/6xHUuR+h17raqV6sSSAaT0kI9GfIPmIOXy9ZIaAoZjO4ZDgvCyS1YC2bXPKwFm65oD
FHW6MWymjXACthZhLu3F05+vXFMkBc5OjPi+a+3G3o/Kva7f1fV2XCs5rxjy1FC2raieoXE6NLsN
ZF1z98Wbg9xGBnTllblsCL03UBGQRI1KgFC6va25STWG1Oa+Z6VBTGcf6nIE+qLTsOJeSz7sWIDj
gJgIuUn17TRWGv48nbD64lvNPrnkobZWDpWlG+zEhDpx6FoA05fLx1B06Z5hn/do0oTC8X1eP1AK
zdY1l1g6Xk4NKhMIYUjQoAkYpPxHkd+P6UPVfMvXLoHlmQPgErxKBN1YchlPzkptdixgZckYQsrc
n9G+ZCWaDxW1lft/cf/gTP5/M8r+QY07yoEFhttVG9FZe09by0Yurg/6PJCPQp/+hTpRAeD91MY4
ABqomN4zzptHrx/zIDLa8t6ZHB1ZNsIPTjd7h4TN9uH2UxTBP1KTQGeDRl45pe0ZYpVsQldlBWEX
cmdOG77WuLm0VKcmpMOcLFUH0XhkD2BCr77NLN7o3icPrRLXx7G0UB9oRgAawT6r5qXo1JS06AwU
EZxv3WYgK6HsUv0AyF60HctZQiOL4tVuNM5RLQb0uQOhZzd+138tBwjz/prtzK/oDws85w7Y/a+P
SrqX8lqRRXIPmjKgBL7AgzeWNQ3QUNbDQf/G3XZb66DJM+4h4hy1egCdzhV7S0sFAn4CBUL8+yJP
WZnJTHNDkLCPvTHA7Zc/TdTiz6LWtJUFM2SYcTE2pFhwfQMh6qieBzYgVIUmlH1cPu+67jklLygv
7JDKDux200MvBJx9ELfq/BbJbA1kv+SOapBh3pZF5Fv6z3qE1vMvMqBbiR2bZo0KWF/amWi6wXyY
kv9cdSm39uayNdEaJax91DtBFenP5kADPNODsn2w0j16axEJ+5H2w7aOrIF6bx5YE8IQ84VziG8l
mxqiy9ddwpDph4t5ox901EBPIHBQtpNTRszN0Q2ErIFVPHip6/fkAGbWl6L6qZXZCx22jQ19cedh
ah7T6ifEdQEl5n4t2n1kenfDAMHzNt662fM4ZC9upwdxN64E6cvLi+mTsAu0yqr3aAfxWl7qWN4m
++q5kAwQT6R/FU0DKfIyqF2k7qKtN/1T2DurfIC4a12GyZTg8V9uDL3dtjkNbGcKsiryURV4odnL
9Ylc8HXZYiHrAPBBvLPP5zFq3XGKCvRa8K6bX+fKiB/i0oR8RjmvISgWtjHyK2gzkqEwsPvKkmUx
1+y2w5LVWlc/sK6Yd1PG5zt75l3girr77LKhfoVksHa8PshFywCAIp+NHhxkac8HaRvM1jPUdMLR
BUscJRt9furmp7KNdyOITiDJfd3exTEMpDeyjQBXoS9AKmGd2yt1lll1VvRh6t4b8/0/179+EVpI
KmWim/B7VKCwtc6/PgvNGgnTUb+pbC8ATWjiAw88BLaI0kNpsTW9qgsXUeypN9fYaN3ojX0IoeFg
yhPDLwkQEMgGrkzbRdApDcnKFLJfQCmofKESGMr6cRpCveE06Gjs3gNMYvquln6BsPIM0WNrDRe1
OJmSwxAtNKgYqTWpysuHwqRWH+rTQ2fpvgZ1o+pLd/MDRw7txIz00JPbHxFMz40JZswSouYW85Pp
23WvWFglFA2xu2QaCM6h+HhHzbzWddGGjki+DqLJX8ta6IHpRfr7dUsLU4YWMANIZDw5ka5X9rFb
UGAr0xKWIvoDXGPPWuEdozHf8nxY4/tcGBVIZIG3kGQx1kWWo0yF7sSN3aD/76UawLV+JM7n68NZ
MaHmNdC/6mRFBRO6dtfFsd/oT+Naf/GiDQMFIoqNK/NN58tfoJ6apE1Uh13qjMjNFBxBTJ4/FdA6
X9lEC6uDIwG6tKhNopFZ9QMjbmavr+oWxeOtcI+2OHT8MOU/r0/awlYFOAHd0hKKjsBZ8YEiqpEQ
pFkbQhnFLvyq16fDoDWGryN1c1/1SX6gg0hXgCSXSfqPO0rSCaNyjbysUpSI5mJIzRiDy/kd2kTq
6L52nh0d+/XZQn2nf2fpM8jlC3dlcy0c6GioRoyG+YTPq1kWMeTjrBlVG9KesWOmOSKAtO7aE+Ey
vAavBrawVLPFPr4QN2ycYppGKqowHvrPuW68cUMPuBlvopxtAK9hm2SoN3pjz4GXkJUn8qWPgrcd
RTgkLNGEge197qN6BArSiYxFGGd8wwioslvi386Uhe7nEyvqbrPMompiIorQK8mXEXm3SLjb674p
f+hZaKiYUDZbYlPwOI56EdLin7l6HVAZB7/M3hoeh/h7nYTOzYggxaCM8U8O96Q2DQ0PhiJMzACi
Jr6mr2FdL/0Ps4btBrdAiy9Rzw/h1U3n9rBQ/dPe5yu7au3jys/PehdilDM+zoz7Wd/w6PX6elye
SOc/Xtm0OYkm1qVYD829az7P9FBkB6s+XDey6L0UCSsXzeJABioXbEw9LbY7swgz5y5uH+bkntq3
An/ktgQ1AGQ1JYJaVf3uoPfLaJYUIQFrp8+zFbddWAZ8HvVjQIuALVIR2m1WWdTUWBFO+qY1HF8k
a2mcy0NbDuBfC/IXnPhpC8CM0VdFEcLFdlOOo6VIDnXm7HUaPfTVGn/r0oAAMkbxC3BzBMTKHZGk
UCvuUO4K8Wl/NFnA9JUqy2XtGEuCtLF8l0phAjViJFHljtk0FWHOovvJS99jUTxE9gBuc3Kv9VrQ
03xv6cNdokOXQEzB1FSPKV3T7JXOpZw4Zz9DmVjTKTuvYqQIBSTigjSdnoFS3UqZKQcsioD4/0lb
sXIlXTJwf4wdraWIKUBdckFdAEJnV+t4EdrcCScvPyRd+uBM3q4FH+8siq3Nk8cpmX3dqzdmJwII
zKFmnT0nYB0mLds26I/2b96FUKdE/yay+LJXULlDhsHrqDBIHupzCyBHWItyk9drBc+FAx5WPNTu
bGiFXhRse6fSxtlxckCgHmb3PjKek+w1KWlQt8zvx9eWfb0+rEWDeJGAKUr2PatpL7T7aAIK4kXY
ls8O7yBnt2tQ10uTR+wpv6sJMgns9gMNogZQspZy3BK1fb5ZNa0SPOtxHJjNYci30GNCX/lKemLh
0Dy1obYaxBUePz3FuBKk79wEFtLvqUhudwpJvwmkKXoOLvXDXIGsLy2cMozLt6l5Y8UXZny5vkAL
R82ZCWUDpsJyIOpll+FADn8Mb3/96wvTdPZ1+fcn52aPzRSRFgNIjAcKYLFl/9CyYeUsW7glz4zI
vz8xUnEj080GRnr9rSfF3iwYOL3mIF7jb14zpBzLTdu2E+64MrQHPzE3MWCL7FiYa+4rb3XlTDwb
j3IhWyk1BSthhoohYOy3k0MJ0078KNkh3b518p9Og9xhaQXu2OxLmvu02JdjFIjq2Rs0KLe8cfJA
CuFT7aER+SarvuFxE4yQ+fE8dpjZuHWNxp/AQV0ejWJnpP1noc874W3tpvQ94w+ISvySveXdvCmN
EimtTePom3gmmyxN9q79m/CvrIx9lr3O5OeExEZfGUBQfPGSR6Kv3b4LPortjMyGLNkDSaF4Ucon
I8qLspaYBmpU287OVuZ82YJkVjVkc76abKzsuawpdA9DQ5+C0UVP4hrwdWEnyGzhfy0ooWKM/vK5
ctI6rPTPPNqn05utba9vtrVBKNHi0HPHc9u8DnX3p2E8tOXm+vcX3P9sCNL+yT7jfUtqwvD9kTzm
IzC6x1ns4n5lN0vvVrz/zIqy2ITaw2QZWApIHN4jseXH0R6xEESTdpo2br3h5/VRLdoDG6OLd7+L
PIOyqXVGcg26YhU6BoqgjnPfqUJCd5Cz3RjafXwzIwD0oHHPo4cEkAMXaLXzSbSRMbH6MarCSZj3
VvctL24u2UsLwBqAJNSE4LJKzDEbJp6hcV3jUf+QQdhrDQK36GYn31dG0M+kR9dthd1ov1v5z4q9
Xl+QRTeTFJmSEwbvaeU4N/NBTE1rwAFANFsNr6nxNW9QbFgD86/ZURbe41aWskivwwiiHqkz7Jvh
PnKfurXHz6KDUZBmYLkR2qllIC3rGAh3aB0y6qP604lDqft19qZVgVhrG148ZU5sKVtUL1LTiyvM
XTS7u7oQm4GzI+/c2+MSyW753yEpe7QUdeGmBoakRXu3tiGdtumzNTmDpbFgvuQT6D+dd+c7RVIr
Egh11qFbthvu9UHZ9/s2u5n0ANsFoFXw3MqyL2jyzs3wrI5ci6VNiCXy2fDsJi+Wd9fOkClfy5cu
eZwsLgMwiUrOBd2lQyOTRXbehLNrxr5hsmMJ0EHGvWOSxy/Xd9GS1+EcRebXht9dCLXiz5M6bUoM
C03E9WYstlA0MaHbIJ7ddIVLZ+lEQFskXpM2uG0veI1mmjXcilkTuv0XggDCNnfXByO3ononnBpQ
3FokmaGJKGtAnASlTX6vZ98ssrObP7W5/98sKZ7dRFFFIoJpsz+xcYPm+LjaRZBbnz7/hR203cqu
aElwpByiTcTnIp6TJoxNFKn7kRzSPNq0WhWmvXXviWTF3qLrOei7QoYbjwk1wNFokpOKY1yJ+ask
v6AiiwTlTz3+dX1YF14HBj2QBCGAQpES5ALq9PVo9LCbOg+F7j44OOcIkuhR/mmMhn2Sa/eZucaJ
rX88tc6cAzbxQEKOGc2tqLYrYU/uDrOoMb7QyMCrqrdUD6rOtA4VdYp9w2O61fIyDpIhKo/R7ORB
NbfVm1tE/H7MxmwDVnDvDroy6c4qYrHhiL+DkoEGzPTybGeIuQd0m+NvPR7QqXQ2Vpe/sXjst15C
NTBrudzPUs3cEDMzPvHaibed6Hrwc7fjlltjc5fTTARTr3N/mGZ9P1NOfdEn5QMKktrWSNPhqc8K
51uOUGSbVfbz3PdGkMDRoRHZ6TkIP3q/zT9V04M+ste2co5vyVYk9OhCiSp/1Y5aPr5QzTim3Mi3
ZuKIbS04EN86qX0H3TXBYNhFkJI69wV23oYl+L1eRloAHx1wgrbdK6mnPxlvBz8quibI6pn4hoFM
VwJ1ch+EfOY+gyJAwMX4xdS0fqM1JrDuHqS9Oy4GjCw2grRv7aAidne07PKFleL/SLuu3chxbftF
BBRISXxVqOhQttvd7X4ROkqkMqn89XepB/eOLReq4LnAwZw5MI5YTJs7rLW2sxFk9iA+q72w7uIh
MMzkt9vmY9hMZR6Rqi39urAJMEpp7LcCXaVJL4RvjfgD69BVXKcTNDxsZft13Sh/dADurwz+uxJO
6TfFRDeQbYx97dF0P0g4iSqJaWhnNnrgxF3ng/oxbeshVxuDTqmfWsIK0OJHBEbfp1vSCIbOBnO+
q6EN79sMM5QOQpnMyfOwxE/+ClXV9NAVAKGqjncbYdvkHiwThPyxN4PWgJbtPhHOuNW8Rf/J0emP
XKc1rphj+1LOdCcnpSMUtwAur3IpTrqxf04jM14AFWzRi0sOQTqUtT8idbO7fB/pO8u5qMUvCtFQ
YEDsseZ1zpCci3uzRwCu1Q0bG99K+UPdv2jm3ACC7cuKPNSOfXTlXe1u87nYtnH7ODVbA/1BLVQm
4VH4hSNxAuLbAnhvqYegQTBapgOOEpC5UxYO0FbPHMP3RlAufw2m4Q90DGaYmRKtfpMI7UOR2b9N
0Hh+YDB0uU/jTwkAN3Fzb6XMp3orLEhQUPZojvrKEpxdgQV7i1bNkM9ZI3DLKUcGUaK5q65/2Whx
DEZTFM8/EsgsVh+uuS6r/Wqs1TvltkmDozEgX9PdWJ3hT7gSk7zifC0fWdm7N4OsbGxKaCzzCoNo
9sXNn7T7cuXMXPn+8pS8CvOM1hQwd/g+FBP9Tnzn196+1QT+adQMZhICemTU3wG7EwaHjiWeB77+
jdij9eGHfv/fz6PKuRQ0QJXGv739/SbRrBa55Z1csplumdxf/jx0H6y3K4QRQBdBBhWYRxOJzTVf
ra8tCHZmUPYmIA5sdJxNfyZaQNwk56aCTG2mgtgrwkKM+R0yOU1IJKwJICct7Ipp+bPT9cFY69Fv
nRimuueT7yUV9Wc0h/M7E8UFP691g3YE1PJzu+yeks4eH/IuV1DptLwoGTS9o9NgPthjZ4dt3nu3
1ej1u9xMPtu1Hr4U1B5/6UKCeEpc3GOrV/LRSbMi0mNDQ+Riy8BkQ+JDiOtH3ZkFyL4G/Pqwq7pS
+BkkNXYonhUbkrTVvhGjs0uo6uE1OHPYOkNx5GKaosZg1bOrQZ+hjUTjt1SR+3TSQD2LxAztqgb7
KIVkQjdXfDujErHReece4l6PO7Mq61CDaR9QPEW+WRhDNMsGWC/IOYijFRO8PpnjPXqq6NDuSol7
TsEBojT5U3lG47tM5ff5yBAmoglwEBtE+JBdt6KKKhQrWsM85VPTRA1QsVGn2u/SZjKgEDoIlYd6
HcoElV+lRXzjJo5xV1il8agLepNAoqKeo24qxwPlMaJDjtgtBehp7yTttLPRr35JQG8SxyUI5bxf
jCHWElIJHzFGEsLKGxFgU1jNQRLkLHT2tUzyKUy6DMKqrDTCRBQCdtABQPemFeIRJtwOcuhCP0jJ
f9hVNiBPB/U9LL3m6BM6l3xHaJf6LUtf+KQAWh6H+qs5C28I2graiYFCpWRSkumgNL3inngEXTfh
ff6wRkCPQyC4+DfhJcaL1bY6IoMiMgAO2n22Jqv8EYOH9ol7ukLmEKewsfhvZZTtl9lGWhvr84SD
MUVoPPS7ICN5mivwsnA+xLNXVNTbt7SzQpbMygkpA6QQZ9CqdgJ0y7SfnUdA/NtAABQaFt6U7MrS
6YM+RulFtrn5UBrSq310Geg+c6L1D6h994FB0qn0lTV8jzUvHnqoAofx0KRJIN2UBP2Yu7fo2vOE
98TaVRUx6X1Nu2QrajJjcbTwU7dP9mNRqDtRtzQyWzkF6XJIJuZW4TgABkGrHussfmb2JL+Vidfd
p/Zc+yUW41lCS8XZx1VebAa7diAsg7X30a8oeXC9Du+HWSaf8qb+Bheq+AKdmxcoyDN/Qs/ToKez
A6gp0ZsMuzSTkW2wSeM91pZ/sSe4d6gcm6GgVRvaxVRtMvCsQ1TCXthMGAunFtytSnR1AGuGf6ih
8JO85Z8RyQrcj6IMjcTWkTsa+luCm1kHHPq8t7RpO0wUD26Lnqvj9MOVP3orDZK49Hv7dwIFXJ/V
WRaaQ9Fhk+EQtqxDBhkaWluzkIATDrwPZyeuQtZyuWknmgclRweBwhDmxu5Vs7crTkMoQbvPmkrj
0Is4CfJkSgJIz1JIfXncH+B5+HUyGsHc6MYvhKsOqhvgLsMZzmABdR4oMYgtzezmi+4p+eG06Msz
IykTFi4CL0sgXnBSMWzn3CuCArwAHxfZCMSSqLN0VzZBI6h+cnNbB1YsvG2RqyqAYvH4p7eVcUSF
if3oQP7d24uXAWxPhqg7K9pgUsm0g+ExgoqlQ5gbvflZ2qWuggmu6k2djdkPRlCY8YVKeGBDq2LL
ldMfbNkweJPEjQbwrL5YXda1wejVZkj6vt0m0+DtrLKlQY6c+Bf0rvcgUq+yT1bRii36hCm/d/r0
2ANS+gD53Brmm4y7hRofoHGDcddlkm1yQvRj4TjTg8yhl9O18P4T+NJh52XVqSetcyDQs961HZmj
pHayrzoZCriZkwkCEyv9Njfc4yTANXJ0bPhx1pLJT00vP7YFpTfVlCPqMdoHZo5lIGMO3LSJbKfU
v/K4EFASLbVP8/xLqsCNqBIy+kXstGFfULExCMTWCC/nu2wAa454lelnAE/7rZ7FrW48KBdx2vtW
ProAN2WGr2hcRjqv6spPkbk/qMbCb8KPukGVDg51m3W3s6X51qiAULchkRw1aJsV0IlUYcomuoNE
gLmJy4RHo82LoEnM7hteXZT2UimieSyQtCXohDIKgsa2Gc50D0TAHk1ePKhY0yEcCFSn0tHkt03f
5YGjSh44SQmHv03VSXmJeqxlXWxBRpoCt1Ns4yEJgBbW2fi5bHM3bIZ29sFRMO7iFC3GQYoy9hmP
2+0CyI1StxsPvBVDlBe9s1FaIiiC+d+rzBgDFDidPUUJ+akruiEgaJThu0bShG6Nw6OhVxa5ae+E
M6Sht2SCzCPUPRD5jLZOwqSFoGgWt/QmnzyyszL8g8Wgc0+pkBte6cIvBliNiWTq4PDRjGRTZo9a
8mRr6waY4Cqv94Wau+dGjTbgux59UNrEjy4VcIdQ3/6eQffDH72p8bnZS1+ydtiWnZWoUGK1fPQa
LCOIZJRo8MrR3MOK7dC1q+ZYl03q2xMXO4VTjDst2ic6UvFTOp0Me+X2O0vwYRFWRzPduftVMVv7
rSuhmoZMpT9mlXnEnY0DdzKtTe1m6dZVKYx3CymQvEeL1yH2klCWrR2MRTP79pzTfVuS/g59Lhx6
EA6fBj+VsdzY2nnKZFIfxr5roqo1cGidOQ3zuKqiujOcQ53Y/aYpmOt7vVXczjY6Gjq6dkMCivax
rOFWpW5sBIgnqyBOypesNGY/pjPdI3UYbxqw7zaDR8GrN3IPnCFHg0AGLPxUMx7Vo8NBJnN+elBp
UkCtvvR9bAYxA/JXdpaxVT1YCMpRLkrFdbxrVU2PaAWe3GqSii1kSarP2UziwGJdu83y0g4KzVXY
JEKGRpG6G2ZUalvGU34DtwBncAJ7Y+xSY6OqnkeQpn/okpQj2+daIsgbxbYirrI4rBzahNPy2si2
x55OAMm3Y0YfR4oAiGbEUIHJZxLQXuSo4fVDGDvZGMVaAxStQXWfZR7vKt3pu2IGj4mo1rnDRZqi
USbJfaUz406VVRry3iIbaZJhWw3jFE4N4H7A4xsyRHPrGiwLxJZh17nd02Qlv3NWBbnN7hs4mJHZ
pcMXxxP9hF4/RH2z3UkDzNxlvyjU9b7y2UkiJjmU0Yz0Z2ZmJkgTIDll8WwHZQMJct3Dl0WiCK4A
60HpVbERoTqS+k2v3ZDN3hi1nRiDuFAq6muabCRxWn9uBrrjZtdGOTFx6EB3980ePKOKm7AYvLj3
6CxDuwQHoqbz5CdO7fmjYdlRQisSpeYkIghRpkYwmDU6MNFymvuNGrz6sexH8EzS5Esy09RP2la9
wI9IWUQLlZxSKvsb1jQyP0gua+RpGCXbIQNuUFJlH5ji+o4n7q9BgbdfVzj0NEbbhbEb4ZoOiYfm
tQPenQLvoMgrJ5pk3+6BU+qehspMN25SlS+2lbs3yEW3n9yWQElUQ0HKIQm6x2XIUVVHlczM8HUZ
I+OjNUDPad7Iez3+zZQA9NOhVoo3Bf3C8ylroypnGRr9mO4jXDNo58d1vkmhX3hTjr33DDX4uA7k
UHeHcUygjdjGxtD46DEvfuc99CEocYunPHGzY9v0hl+hTAX+oJeNQZs6ddDAxdvGVUs2XE0wDwyJ
uGa2ITljmcMur5p0V/EBlJnM/Qb4TnvIHJo+yCEuPo9A1N70aVX5WRGzYJ568ZzKDjQJ26nCbvZs
5L4b45Nn1eJkJUQEGRMp4qGm2xb9hH0siuZTnzeQA5qLMuA1/PSSd26Q9AzZwXYuoyqpvxCNVE4p
neKmlF19tACIuk3tPtnVaGV5z3I1PrlOk+wNJXFUNDL8DZN/8P+SYTpAkaO0cDdZOvVbDkzcHvFW
c2rqBq69Mr0KaZMhjtIs6RG3VMQngysj22pzv6AINIo0Qe4tZtbGUcy457jYn1rDqaI0jYuwlOhj
Joyi96ux6Y9GNpcbZBqnR0GL9pFm4B/bM2D65dDpjcpiSJ94+1KPn7OYkrCTHCwea0CnAEjx3Fkj
IiYNcxgYtNQbJALpxuQtC0BnGtCjqzfDuC1/x5nqYCx6iGEpYd5VaBQZ5IYOR8eYfDVDFQOhQHtj
m2n7PS917huisW8rdIPwc2SHoQEHxay+GrNDalRZkLRpHWazgfZB6CTOkRIjszUfBoCpoxbp/wPh
XbKxWaz8ZE7aR273VoDijhWOrSqOthfzTV7LBJSYwbsxa5mFteR80zsQbnRVpT9Rs/wlRevdGzbM
nMNr+C0gafhI3+b7KRHed0uZxTGDWExotQr9ZoqSHs2Stwe3M347bgUD3SnzIEd79PUoqW8abr6Z
WdxvUmcCuhjen8/QnCpyuk4Eceoh/zyO5jZhxpKN9KA/Y3VWMNgJuW+cTB5E1RUb5JONAAjnNNID
Kmkw4STSCg8D1GfL7WC08EJ5bh1QU1aAEACbTibq+WlWe6EhMhJkPM33PRPsOHpp7ccDepsykdQv
bSOnyBjieD9bfYGsXD4fuDVl340U6VlPgb0xq+HPJLP8mdoEa8myzwPXZFN18c9O6+JJ2bI+tXk8
Ii9rWafKctFAc7HIveWUW3jiCfK6phUiMTKEMq1s38T+7DtBkG90GnLoEtGjLxS29g6COXHQtUMb
5mZ5l5qDuY9Bno8SPpF72iIr4UhaHcu4rm5RoQUpTZDxmbXm09wWrvRro+BPMaf3dm+QZwIhZh93
tRJ+I3l6SrPhhafpeFvZvAokjf8AedodXcbGg9U35R56xEkgUkibVY7q7WD2hvyhtAodVFgcguE7
w91De2oIMykLvyllHZTCAAwTjYKCWLD6aDemse1Lwwua2us3RRpnQWOzz5BA9nazyMs/GZokIDOK
HHZvp3mUsaRHLKaae6c1gbOz+Mz8qjbnR4fFbO90pgzg8hpb1y3+qDzju95qMqjLOPDLwJA/Nugf
sSmIeZPWQxF4kBQ5NXa/LKE77VtOeCjs7HtRZGKbI/raSJV3yCoAOJqDKxGWJYHLjRCMHVyJ1axG
Z9zEs4GQcpTF14wQ9SUehXNwcDe2SwkZMWJOTgT+lI8aeRJ6TYO8Vl+Yu2qI57ueuKMPDlX12IiM
hghd42OGxl1RUY9kR1sXksWDBS0NmOp0YyTod1/keeuLuuARhKeln3TNb0+goUCOK74jSCRELehr
vjsqEs11XT/AYZ59ko2O3xg4UQlng2+p0bz1ujG/SQslPl9O7L1PSyKr9xdAjFowCJurvKECf4DN
HHy+Dh1/rJu5ulLEPPd9wDFQHVugiUBhvs1LljrRDi/H+dR2d6Pcp9bTx3//q+/TtcJBjCKNKfB9
fp/HwXhNPXZVjv+b9ORA0QPqDPlDpLHf/vzRRaHfHuP5NFRg1YLpbWwmWX8st/1ukKW++Cr3rFnB
0MQYg2RpkKE0/v/8/GoL+CwcPbb4vIucY/XQJB9Lnf/z8wG6AXoFYFdAed/+/MltJidD+ulU6G8n
bX//8AajSRK4sKANodjOlgP2anFQTmyhYYhm2URZ3yzkh5AC+1glf5kA6OKAwAE1gJO6LktX8KKz
WqPFWmwU94x50ncm+8/laZw5SBhjIcqANItei6tNQCmX26LsGNSW7k0NYDBSFZ8uD7GUKF6VSP6Z
xiJeCL4Y5Hq95e+vVqqjFZWOUbFThzcSFc4nBlHWnOfQekOd6fJYq5L3P2OBGAuNc6A6MNzbsSZk
Gpu5LhkeyHGXFf1hjjsgSMxPlk5+GlOHfOR4pXHZGUsCpTMHNDKoHVvQv387pFGT0ZO0YWj7Iv38
kCa/Lk9p2YH18i0kWXDD0Y0H3WXefj+3MvgzZeyerPLX3G4LMflIpkITFg4cWC6oTlweb83e+ruG
gAwABoFh0Tt7NSCrOc/L1HBOZe+aUQNRLlRG1IHFznao0igTqL5O5afRJhEKpR/U9/5ndNg1D4sK
eARf3SukdVuCZkfOaWqNYBoO0rGiyxM8t2GL5fzfEVZ2ocebnqLXmnNKCAjqOJIfRBb9ncKCsMfz
Amm6dy3kKjjLHrJJOBEFi1BkGShKOPXyzJLgg1MBX8JY6LggzUF6dC3PNZnw+we3s08g9QSgSBAk
ci+PsKam4L5iiAVD4kHW4b3ovZwtZbRAAAJEAvQnArTyVEJbz60Pc91sWKG/kLb4asQUJfdymyKh
R8ffl3/DOxu1/ARoyiN4gO72O0rwCAmfOBdQhOuqI/1tDUfzGtXu3ZHACKjHgxEBxhJUVleHTpEx
VmTS9IQmxECUxIg7P2rLMQLyKvgPdNffy1ASp/dSJU0KhVgf2uSQcb28Ruf2CQobqN8uxBUIz6w8
AtYnKCJC1OSU5h1UD5E5TLdILAENcSgbaB55d2J6GoyXhEUq3sXNlTqvuViFN2YKxXzH4h6IJQvx
c/1Y9WxuFC2g9W2yR6qsMF0i//E4IyvJt/xeqZD/QRhyedZn9g2qxX8VHwCzfSdLMZgEKZEYtS+n
jEpyzNqny98/c/Lw1QX4ai+OBLXe2t4ul4QWXT2djDyMu1uqDyS9Qlc9N4VFmMqAZgUIJGtPLi4H
xGAUCn659cu0RWiSK7dnTTZebvCCOgHcdSnvv1NxsJLMAd4dqoe1Ur5oh6AQAaSVhvYevpH903lh
0onYiBqm/iAC9p+h0QuGeSAdQXxl9TYCDlkZFZ7ck93xz/1Ufs0m5wnVoPDyNp1bQ/gw6LsGiYP3
8lHFZKZQxnAngHmMHhsl1D7P8uzKFVthV/5OBkd7kfTDQFDnfnsYoCOOPJck08mzK99oYYuM3waK
mMxAFeRap92zU3o12MppcsBpomWd4DrremcDvpAZV6bz/p3HubDA/1xcTPh56/mYCq8XJwyHmz95
uQjAXdl2zQtUiXyFImUxAY6gN4a+QtY6u4yA/0BVDIcSfs3bZeyHeshAtJ1OaQdFXqDvPo3VcJc5
SPOzbqtz44plOruSS8OGRUTAZutIMjMahiQon04u6mtZWtzMtv4vQ6A3BJiCQPiDyfh2SjUyechE
2+iOqes/hooPbuFtLx/x5RMr84qH798hVuYdgkAyyZU1nbL2uwkoZ1Hej2Xup+zKqTi7Wq/GWcV8
yF55XhVjnBL9ZXktkLa54l+eGwHJF7jKCwMHTtLbxUphDOWYotfn30JSQgt/RJHvyiDnDjcIu3DC
DBhWRGkry2NMDW2awhpOSrtJCcxik0fNqDzki7nWAMylzS6XVX6c0DXuuXKEt7GH8sflTTtz1ClE
YCD5yykEztdg2IIkpXS7HOYPGXQXuD3PQtqESt82ddBn1zD6Z4dbOMqLHuz7gFdqVMY6xx5OrLQi
u/o6dhrSijrQ3Rd6TQjmXVQCRBeYsfCXgCx+7xa6ynZcs4LW4Tgany2WbJTjKJ8B54AgFSg7NpSh
cPKfJgCnlxf17MhAacNPQ+4DXuHb8zNQu1axaQ6nToBZ2Lm+BWSSAzSxfYNGsXoog5hcU0F8F1Zi
tmhm4+LMovnLO4B42gPR2JveAMZ5NYflVNw5RR2kVRNWHloQAfLcRIVlXeNSnhsWmltQKsVVWY7R
26lSrTvCFV/UfQUKqFtIMPuSWMiKmiH+Z1V/TL50eeHgYcN7hP1F8LyO1HM+Ig/ronmTDXpCgZrS
NT/7jD+FAXD5gdnD67O+EHZesbLrK9x9pGQ9DuAqRP/z9sMx5DKPpYPBcu0WEd6364YrAJSepUdo
vUEWfGb3Zqb2l0/hGSu2aHxCCRs6j/B211ZsIqiQq348ZTX0fCYPdUhks5Ir/ue5A4DOZoDGWBRs
jjUdruCxYoxUUMX1TCBodkwtcIxD3XVBx3Zj/3J5UmceGTBh/h1uZfzbbuonETfjyUyBABx/e9an
iTubWf68PM6y/qvHjLoWQmMXGRro8a2Mc2fUPE1YiSZhQ/3I4hpGeHqRNf3sajSiEyLgvXtXJP21
Nh1nXwXcJwiAI6CEeNvqYFR5n+epJydomAPXGBPUEZqIMY06z6+GP1fIbCT2D/rBnlh/7xU6kCBQ
/9sXax0bEcJZC+UQhCnzs4mcF1N/avLr8pqeCwAZ5CNAnFzabOIJXx16QwD9MszjKTHuGSywBdwn
ye+72AmEq31zfnDKnW3cptYfMuwBqrw8/pkLsTQcgEGGVhziv+Xvr7J8dKhUbgvDOqFxml+gZJiI
a8rd14ZYWX6vbZaq52ydvEL7Y7El1sPlOZx5QN/MYeXHKQq6I0sxB1MCeGBv0m4/1EA4ypfOuuIa
nJ0LkON4PYECMP7KVb5aLmOmli2BKzm5zk8n/n4tVrnyeWtVfhgzPnvgdODzfm1Jf86vJe/PWHIX
xDmYJdg/pGdWXrzoKUAQwkR9QyGd0Eyd+dwAZHrIBpNdeZXOpRYgDY+gCwE+ktV///5qraZKlzO0
J+dTC7SXKV6ofTMTsUmrzzT95c0L4qLZecBF0ytJmzPm983A1tszLVlmJyPr5pOSyRNSDVFqf4mH
U2vpcBZQs7gSRpwzTxiPozkfkOx4wFYHvCalDT9Vo62dlfxwMuNHbdVQo2tQuAbDRchyawj35xw3
aA8LuOTlw3/myEDcE2bZgM4n2L4r+9HxmnkQJ55OiwYqyJcv/6/Pr5Wr+zITU2rh84hJ/aqJWu/P
fxgALj+ylYjSkap8u1mJFlp6QzedioR87kYDHnfisStxxfKR1csFUcL/G8Re3au2N6TBhwbBa4wB
kNx4LDP2jJrvrzFFsdwwXgif0WcG3bovz+7cfUMDPVSBHOwRsM5vZwetC6HNWCK9pr868LHbLaA4
l4c48/qDBvvvEMsBeXXNqHagK6uL+STAqvuuzKhQu6v867OnzIGC6dJN2YSX+XYQbRYWNHwwiD2H
kH8rr63T+Un8+/3VlY0nYtQsQRp0qDc93yYmhOx31rWaz/nd+HeU1W7o1pu6sscoUJg1bF98ta/N
4+wIfx1YhLEgDq9Oc+VMbdamf+N9pLRyL/2WW/rOVCy6vOlXxllL53hpquncoEcfQxw3Wu1dAhSU
z1J9Jc15fhzEbGDogNe99pfjUgMe3iFFx6rbEnwbfQK88fJUzh4t798hVt4rTxQkNnMMkQAnq9Ho
jckrl/Ds4YLbuHB2OTzY1eElgM1VWjpIwsB9LAcLiE8njOvDYKn/MBcYYnTasJYWjdbyS17dxQzC
pNNEKErvKL4BuX3l8+d24/XnV9FLjqCVF2BFIAeHFki/e/A56H+wJvB3YaxMuDfI/r6dwaSJDbYd
FKPTJhR1kIC1HTjX4vJzW74UllFcofCl1v6825NZVhooC28GwtVoa1967PnysTq36ci8oakSinlI
N6zWysvjGOypxDh5LgRPpNrJuEJTSRMiGJvLI52bzUImNCBeufRYWf7+atNBvkACgqCrrau8fmtC
iTFMkG/8aL3aw/fRi4wiIYWjvPbcDJcwhwh4U4PekAjw1cuTOLdc2AuTof8dkDtr0rlTAFoXz2w+
TTZ4BxA6yl036qqd015xC8+dYSRlnEWUAo/W2kJaumQ0RRdTqKcZfp99L4EPLYvd5dlcGWRtHkFf
0XZXL4NUSVA3X3qKpMi1dMXZQRA2LRUaNAhYnzD46mUPV2XEjqigIH8wlt9cK2WdO1xYKBTnltTr
u1KMhXydRPVuPHngmBz0XFvbOOn+XF6u5S6s3aPXg6xOcNy4cQfK/3gqMqQem5cSkLXafsHO8Oq/
DAX0DYjUQF+8C0AG2hd8dsEakyM46ZahjpyYD30139bSeVag0Fye2tn1Q/cA5K1QH7bXpqbOFVVZ
Q1EtYTWo/AgM7StG+ezN+XeEtVRQhiyghmTEdOLuVhK09rxdYOXXBHDMs6cNuT2ousOBgaf/1spA
x7+uW4qFK0ENhWdxO6AlTp7rL4nK22PcNcBhomCCzHHhfSWdM4FrZoF2Po7eFpx7UDT7ULpFd+Vt
PRdroWHJgmZDbgYK5m9/Vl/lZkY6lAXqQv0oTHHL6i4FW7YVQQswhc8Lo982ZfHxONx9PezqxE5J
PQCjmU4nxYYAoPboaiXvb+uB9aVgS+kV5wYltb9R3yuz7nLR8RQ0TcwsHpDxBMy5nLxiA2fbORqT
qY9QWeB3IE6BqSeArhxLUkSyyJp9w5t6m1hVExA0ML0SkZ07CIsONTBZSxy/LsRAZr9KS4oVl8Mx
/do1oZFGl+/M2REstFmBtgqE/tdFGJGCCS0EjpoJCkPmKdBEnitIFlwe5dy9gaAAFIigqQBN4dXJ
aTzwkHoOG51DcbacwURQe92Crnetf8u1gVZnJfHKsu0lBoonwP6MKgSy9n4sxtLXnH65PKlz18EB
IAA5SqSH0Kn77XUYRDLDXqOkWBJyaw1TVHGypQIwSRN1o3yQi9jFlWZZ5+a37BNK2+C1vUubQwMi
jT0FJn0e31f0AW1J/AH0wqtZ2CUGW1+IV+OsH1WDT9JSE7y2DFJVFXisGnhmPhLfyD67+dGukGHB
hZeHPjf2dWtdseTnlvb18CsvvpigKwQINhrfm6GeAjV/qfTBZGFh+Ya7u7yN514NPLpYTLzti/TH
220U2dgIp7MQKCqLg7MEIZoJRITLg5ydECpxJvqgA9e9ztx4UrgVT7BviL36LfRg5hu7SeIgtluk
j7IcMs90yJ50kU7/ZSnhuMDV4/jH2sm3IeXjoaEWEmR6pyxI86BuMFufhEk33DmZ7hXX9Yx7AU8f
CRjgtODJrF1X5YmBdzEQw4w8ILhH45VaHbGuUDu5vKJnDBccY3hiwChQpMNWt4+2zgi1BmmcwJkL
ZvULJLr2g2rrS1EA0AscC8CLgBmgy2189Sxow5yyCTyWUzV/iucNG/aX53Dm6OHLy9fRsfW9Tmdd
JYXZj4150jwYJ7+5Jjt37fur32+oOSk7OzdPFkdbdXP0mw/jz5cVQjtYmEG4+e/EIA3kP4p8so2T
kWa+Fc5gQnx8iSBKDLSchTfwncGrPQ01Jts1T97tJG2fgDd7eYAz6UIc1eXTePuB1V/O2as9bo0+
1zHtrRPNMzfseLGPJYPYQ3e0R7ZTrM0CNfAZVPrs6+WRz9hyKH4Bk7xU2FCyXuWPujIzSrKA62cQ
2dD86zPhUV8+/pdBgEpGr+elq95yX19ND/p5pnTH1DjlRif8fJr2XWzEQcrnZ8curjiIZ2dkIXGI
Shpd7ubbwejALWIAl3zqtPPYdfJpIaL7pJD3k3cNfXXGoqII/u9Yy99fTYxoCCNYY4aYv/+W599M
9eCIEDgRoNggsnXlkJwzNiiFArQOCO978XeornuucoHF6yEPA1fNbykC2jS98kqcu68ozYELgR6r
trv2KCwwC914RnGhtNuAc+iSXClfnB+AoxyOScCerQ67SiAzZtQO8sdgmrGjHLsrC3VtgJXFsZ0Z
sILWnk+02TjDof19+TSf2wcEdrA0WCLXWgsJjWpw2ylGSUu+TMbBs9Ex/r9swSKdiDOMEvQ6+c3d
IZ0lRz3JK37VkFTLrxm09w8kAJ7ouM6RYcd/r7WZTSgzS8CM3XsmQDRLDgn/KqAEYqdjOMorGd33
u4GxgIulAAIho7S+j1UJpr0pJue+Mg/iKOIPn6a3n19dQTFAnGku8fnyBt3l+DWf6Uy5HBgpWP0F
po9i2/rn8xq9Ec2+Zfcgh6YKGkTzfZckftfsTbavLSN02l/mIr1BjiZkCcxrulvvT9vb8Vfz49NU
gXw9sHvCnxtIYygBXTvzyo05O8gCmkcaFvilNdCi50PZoBcZADDiselA7i/Q/Pbhf0g7rx25jWhd
PxEB5nDLDhM17JE0luQbQrJs5pz59Oejzt7b3dVEEyPDkGFABldX1apVK/7/7WvzawDl0p1fuipp
zqcfC09DHFApZpotYlxgj9x8daz7zBx2Y6AZn8Iuir+wy4AnFNlHZ4JlsytVDUe0jIDpSxVA0tMS
HJfWaZ5G1apfGMug+gi4aPSlkzr7roUx80mPwuDU5l32MMdBdmcEdXJXarS4yRMdB+CMqJB45h3o
6EY+jY8jviOknsusEf0QD1Pfpt/h+A5eqTxBQBjbypdkHqUvwWTAQjmF5akP0+FDV8Mi4Zspo27B
nLh5rCQ7K5us/ZB0Sn7Hw9MzHD2XLzGT8gzC6NrbGDuf2qL9Jxok1ZVCOWXeeo7a+UgeLHyopyn4
Vkz2/FRPdvdgm1VEr1Nfmf+M9JL9narTFgnnSqEcj3WJAxTcSpnep8tnC2in1q9aQ/PCEmShVNbH
v4osN+6GOO92i7I/GckQ3dP7CDqSnoR7wwdYm9RjtWHorvWOdMIv343NJjcveB9+MzVa7WuapxvH
uXwEmXzaQgq+Nj+LCPRtmb2Do1BwB+YISsEUtjiP0wDtggTDbbVeaZsna0GSHDhTzBxl+cvNrKDK
qkvF6r3Q95nR1/zqTUshBHOdokw+akmofp5L869p8otjnzFTHpZ9+wIaQSa5heP3Dxu/ZwlLL68Z
7gGZdSAuraV0uuz5mU8it5ZEt5I0eLGedPuyk9NDbkMjC6HqaKNt8gS1FuMrduh0n+hGpbmpbQwA
2y0mn2//luvjXZJZMt4EqWQ2X9gaK2coXM4MzErlpYBbgDmzxdd6fbwXIsQcgdb4dY4WG55z7BKm
uo+3V7D2UJL4spmGcABmF7WnKLiyYxeYniwPoKLez6AXZy1ImI8BYAm3Za0v5V9ZgqUfq1ZPgxpZ
U2/fBcwMmOrGdVuRQCsOcz8kdIk2xLqkUixUp7iYntIfy4OxNcVx7XkTfuFOLCLwU0WzYgUleelA
sT1l/NQRa1fG0k52r2+lC9eWocFcvQxY8C6LmekmjoJKUnob8uA/+6fc/nr7HNaWwToWQgleIk3M
d1JHksowcExP0Rr7dbRnYMaMSvo8p9rwYvRyujHoIJLm4n8BZc6/6RlmCPDKggB4G/RzCteOAe7h
61BOD4odqvOhjpIZlEVbBl0y/2bLZXIY5qR54aJGbpznkIvA7gCSBHmpxm6cTwVvoX2wzbQ6TrWe
s/m2tdNKNfmOsVBfF4SmXSEV3efbG3Z9zRfXgRkNemqWcp5wzYNUaXspmzMPbCPZ6F1qYW797ioe
IOV4DySuCEuu+gJCgjod3InYs+RqN9OR2ZgjoFf72yu51qxFCkk/HO8Vvzivw0KNOyv2JODKnXA3
zFtv79peMcxA4EMHzfXgcRgE06jLeeJpmewaFvhEcucO4z/vX4cGsSJCyOiQuLh8A8ZiMqgSF6k3
RbvidYo2tmk50Msnht7Ys88v23j2xMRKO4SDwed949scHaT2Gcyv16q9i9u793IBLrcDxi9CB6wW
GVLRBFO2syZ5RLvUPP1ggUHDFNB7d8uAohE3gf4AKD7EtlvmPK3YbovGK9V9I90Vxf3t7y+G+3K7
+D6xLqOpSy+4eD8iXQ4jR4sbT1Gb+EMv2+FnWerDx8QwIRT3++FBk2TLHcNha8z9Wp8XyUtfCPy1
1wNvoV6qTdpWjdf+7FM3fru9rq2vCw+WPCWAiMV141VxtDPbh/43Em/U3Jg+w31wmIcVoRmcJAVq
C5PnjcAqTW6sbQU+a0vAZHEqpKXZKeGiaIGi54rO0U/1i+Q/y9rmCSwpYOHw4cY28MMcXNwrcH2l
U4GGsgPVa5F1CPLB2Pk1qJE7Oc0s5z6Yu+gzCYViB8yIvislwtmd0/YV6R1/ilRsgyF9L3yn3rWy
XwODb7yhMYqbMsgrM59kdkeJgv1r0qv2PixC+1g5qQRm1QSFVArs46ipn8C9N15s35Du4zCnRXQc
ivltdMzJdBUo0O8bBpBKYG8t5viKeH4a1Gp4y1re8MGMBnqYGsmSdk2N75jXpbURwl8/uMSFAD5R
F5BJOImFuTyeqqBvQQcytH7at7goLyr1xjsuSv4cjlSa3+1pIZDghxwO6TSyXJf2a3bAt68IkTw1
3TMrDTbZO1mdlpQK8wN434S5OuNryzNwZiETwp0gmGk0LkPtVZnaj7OUbzhz1y/JpZ+/7OqZCCMJ
MrWSk9Gb6wfJOQbas7Y1hrNyO2iTg9JH483F9goPezyB4w+Q3ehN+csymib1P25bkJWTPxcg1k8S
AnWFx3D0jE8OTAL6PUTDzrBhfjdWYQl1PBVGgmFMEAJSUVwD7bqhTWsHcbZLlnp5EOZE/KQm+ejZ
8p9ZdDLDu7z4eHufrh/cBdmFOTrLWcJM0UyFfjs7CnhiXp1Ogw5IRAbyN03Y+c8KgoK/zCYK3Lp0
4KuwCnV2uTxbhvJ6kQtsOjeUGcVlFlhQBW0ewjBqtc4bB8bXHBAkldqCzJget9tL3RAkdkFM8zwb
ia92nqTsocCZ0uNobtyc66COSw2I/eLgL80AQkrA0LNRB8Cw9XhS4C/Nsx1NwK3+2m1R4K0kWi4l
CS8kYzZtMWtR6znqH8p8MMKnZnxT86MBHV/S7CvzLmof02yLMPRa4y/FCoclTWaXNQZiY82YH7LQ
NB5hEu8ebp/UihQqRviYFFgZBBTz+LISRnoP2qfn0+w2x1+yLda163MyaAzl6ScGWxKTwjLCRLfS
MjAUbyp4/UK3drp9AU+Ls9flw3vXsojCxwDdaMEeWrTyzJg2jPQ0Mw3WHtjhqfnKaPvt7//iYxbc
AEaGbPLgy8AGd/hSQJy1IOrnteLVcpI9ygABHY2u71+BaFYOvZlqk9s1WcRo7FjIUNgP5mM82bQ8
FIFKbnkynoE5a49Ag2h0AE31AQzs4HNgWtGxrGDs3Pi914bZvDhb4XHJgnqca3CsvSmRqh3oWP0u
6vPsTcqS4Zj4YPLe3p/lKC+3Z0k+gzeIjWN0Qax42LakJAkoqp7/5r8poOVNd8lOz3daflcPG+7G
it6qtAATpzJhKpNvuTyKaATSe7YS1Sug2qvuQmd/ey0re0cMCYgGCVZSg6J3AWxBVlh6qXpD8xwD
92ztlOY4/bgtZHURIJqwbVQmrhBNVOIHM89CqIDVPf4RFAP/7fuqsEl1OTSNubit06dM/wIF7O3v
X9/tJdD+9/cLLljbK3Ge6ZLiDWkkn4a6bT4otDNDpCH3GjiEUP685IpcbYR6y9kKekYkqS79g0CN
XDWCSwUYlzlpU2+S76v4KVP31la9a0OE6NM0gQwLuOkrXgLwFrCVqqtsQSNsiRA8mqnJ2tzJEKGN
T8mffQxk+YYOr0j4hTJD0hYkIhIvl8dvp7lUaFU+e4kMCUWeQnqnQnlmGvXbbT1YFWTTVkg5FdgN
MdmWqKnkxMkEv11dgnWqPvUBIOPxBE/UbUErCkeqjBwus9ikRcQgozOIcfy6YUXReLDnt4YGBDXK
P+jgrm7yxl5H/DwjMBGQBSVjdVXXCP2wGRYw05MJwFKg/WP4r2P71eweIqBorc0Wm+tNvBAnJsH7
LpqLrEJcN/9ppg9F0TOVvbF/WzIEnZuhVUkNFaq7XPqQ5vf68Ikhx9tHdG3TLpch2JwRhi/wNmBZ
lYyHATrfZvzx3wQIWh2bStWqCpW8qY/vmvYIXcCGT3Rt+zH8RLKkpumavlJnwHoBws2K6GSNA0xS
RggNgja4QWkdfR1G6Hev50Ka4F7qrT82UHtEp8gcDpYdv4TGZgpmRZVBhSJSXgp0S47k0hL0Hcxu
QWSFpykDxOLUN6+w8XQk95vXKXi3MWD2fcnxQfkFRI6ITdblAFlUoRWdZEsGB+WxLgPX2jJtK1rG
VBapOBwcUktic6Degyek1310arWHT4Z/f/tIVq7JxdcFHZaVJmliha+Txn6l4ehFKaQXmp2qjaNf
OxZmyxYcIYPmQ/GVyaOpAVVFiYBguBvjpyB9iPPYTSSKyPt6q59yS5hw98Oq1zqrkYlt9W90Isiz
BFMIaOyBvNONv/1mqwVpfRP/XZywiSWA8YVksrgEhg3fB8zEggcx2OgSXVcE4kD632izEbUtgzwn
wEmJTqlZJ29lXNWPlsR8+m2FWJMCkZ/DwI6skEhZ1noWWUQlCUDd8CMGJz91486xvv637wue+qz5
bZZHUXzKVPlVzb61qfrHbQlrp3G+guVlPVuBXGgjvY+sIMge5Pi+lO+iYsMlv36cmWVfgIJwOrA1
orth9VE1Zj0HXref2/zJTxLA81XXjEoXcJuNq7N+Iv8KW/7+bD22IZFzitBm2Rz2U2Hvpr9ub9ja
dTlfjXDkNHZZQxCp0cmXPo3GPohH13FyNyvjPTEzsPUbBcS1BTF2SMUSR4rREUGe6k9KTsYkPPmP
0zdAvG+vZuvrgoKpINhFSdqHJ03S3Zey2nJm187+/NcL6tXOGYx4Dr8+6hbo04Na/JnI3/vAe3+e
jizz2TYtx3Z27rOeZ3a5CPIG6S/7KKUbIc3WRgkvZSzlVhRD9kbjJPwlO/Nw+xzWriHdFNRC6N2/
dmCtIjcg6UrD0ww1ikaLft5Y7qxtzS6vHQexP5kxkwk9evYvd2mYAqoVdJWeYvvOcR4V+aOmDECo
QOYT/7y9opV7QiYEtFg0l3lW0bUo4nEIfW0KTjls5KE/HGFYe5TH5k0p83saUx+ypH4/HglIxdga
ZleYnr3qjlH8XK4qxwlOUrCXftgNbWL3t1e1ogZ0iyxlDAOUSXbycgOTzG6liOTJSTGCt0x7UBh7
eLeEZRiLh4taJZUl4UbCZTtIcNAFJz96DB6dccMYXyvaArnF7Pqia9RbhQupjpEtmbrUnUrFdKVg
rHa23X8O1GzDbC0/8zIWRw4NqExoAK1/Bb2nZzQA0szXn4rE1l4Yj+r3tDVVrj8W1l0No9GGvF+p
42uBNGsxBwxWgi24FcYs93I9wtMSUUb2AecMGc5u/4qs57b06mCkkD3vWuX43tMiAASYTSb/Rw5T
bHtMOx5Q3Rj6U27N93WRe2GYbZiGlTzzIgMYUCIPIEdFTBNbnaxoikYYaPLeDWBGgRRPKeFXLNw0
b3cdEG1RAANSZLl6tgUu/StfLu4rwa4BM9uvUXFB4yngt5VOdQAmefPDGIX7pLb3ipkfoz5+NMOu
cB24JCpNO0w5DF9BTaLdzKSDnoC9UpZ/l5HO/y7vq6rfsDBrqgzkOsWTJflKLH55F6VmyorZqFqw
rha6aiM2nsLQpuPTr53d7WNe02aSxxT4mZ66riTHtpY2tBA3p1jbF8yhdPMxBXZ9+npbzLV1YVAH
E8YsM82bFDEvVxTaXQpfntqcMnN8YBb2oyKlG37x2qYtCM3LWD74OGI2Af7NWjbDrCUMPyiQt/RN
QtPFhsqureNciLAOO7Rqclhpe3JgRlM/bCEiXueTl65SzoHOES781cHDh0y6Xe1OvmGTHP17TEN3
jr4XunVXya9KutAHvttPuhQpuBcZQwdTKSvdSSsVhi6Vz5nW/YYpOV+V4GG00GRBjMmq5PkD8Fn5
+9FELpZgCuNspd/pvhnz/SD/O9P+KtXf+f1kXbmNdO/RBnWpvICJqI0uJ/2ph/42TpN9/v52UFbA
eZPexR+WRRrpNJWNymRa7hTXr87OL94N9MVUP+UhZn544+HCuFyA0tSWHlZaR14vus8Yv2nrjgi8
f85S/y3U4u+Jou1vX/jVVwtXhSaSZfzsqjc/CnQzbDIHmcmdM35NwxewG9wk0BkCDw5R+y2p6nu9
vrstdu1+MkCFs0muhX+EVNlgWqEChlV3MlIv/D5Or//t84v4M188nAwl7pyZ+0mXCmSWzbvz/HS9
0fAN6Av53qvySLuQs2ozl1Gt/4gWem5jdMtpoydx9WjOpQgOhW1rnTIpbJJvT+n3VNL1h8wPjM9V
VUsvxayA9AU3tBvN4bfIaUJP1aZs4zesnROjg/QEEDjTwCaYBD03y7mFmvyU6JClHA1pq3K59hqc
CXAEm2D3VmEFqd6dCnMfq3vVvvstXTsXIbwFkhVE8jhyq/Q2OqiNtC//fr+2nQsQzolkXxSCydGd
WuuH8cPXfufzqgrGK0GJQeB0qcw1/FvSbIyYzXtF5eW3t/K8a77F4r1oyjI6A1rSpQDLSCJFciYu
Y/gNxuZDZid3pvqg1RuD/avKRGc1TZBL1V10I80BuJ6qw3rK/kv0KJe/YT3tfz8vThZq8KH9f+sp
29ljN6R3jep4ZsKATjm9BAa1zG7LK1tfEQV3g/59cqWC9kJQQ80dSsiTcx/ButvNW6/+svWC70tX
H43i4CHQFCum9+S58OsUSsJTYkEm2r/G9UNXVQ9y57tzvlWVX7mLjOsspTLiJZYj6EFTwk3e+011
cgr9MJT9nQxiXV5uZWRWNo3AmI5L/D+Fl1S4j3IVqt3UThXlpAcr/mxX77dZF98XrmNl151fdny/
h65KoS913AjB1wwz8RbMTjDCsVNiib8Jg3EY+7ICoPVjCr4UTRX7ERrDFMpz6UMVpvuh+jbl2f62
nVGXV1HUBijE8DdBzVmCscuL6if2pKVODWhdz3CPmrsmoB+VHx/C8UvtP83BneJ/7c0/fVh+5OB+
gHlTiT/Z/dtMe4tCkjttrN2g/zOm40M21G5ZfdD7jezBmhKd/UbRoDd20bdm1zansjmU0r6w7tvk
cHsftkQIChSmWlYuGJGnLv1CLUyrYreR3/6bDEGJLAYcwlpjGUb+Ssow01q3zzf81cVlvz5OSEnI
UcDbZQguvQRAfd9VcXOCynl4mTJZ8uIuotvCgcU4ngttP/bS2wQb9u8o8NI98r+SBUVSSwg3zDZq
TlYGy6R+r5cvcJQewlR1Y/1ktcekPM3h19tbunbvl444JlCI+67yyLAI17liIFRntKRmnPXn7e+v
PGMLUxjtpMCwGdTHL2/H0OP0waJanuK02UXVn41muqN07KP/KGdRzzPnkkZrewgUrTzp+lE2AcR/
jpw7JdpIJ60pOYlEEE2YDsM/F5S8hNE2q6qhPNXdri0f0vngb8EWrukfGTLFWia1QTQRdFxiVrdu
fB6XFOgtQ/loF14CJ2n9R1g8RFvKvnb658IEj9+P5VSebYTpk1squ2Rr+GztpTz/vnD6+hQlAQhX
5UkpX53s21TdB83PBgIZ3dhIYKzpGW1XYOmQilkCtcvzd2qar3xHbk5a+N2KADCgYs2okFb/dVuf
13YMr5uJpKXJ+0qf1RKos2FsmpPfSq7bJVsASCvfpzSJgoHrRPn9F2DYmR4nmazPhQMKff9VVZ6i
4uHdP588OE/BEo0vfEiX25SgeENuQrIAMav5p6V/+Y3P/ypK0brJGIfgrMDXLFsQOYMzH32pohjy
i98RgKPK/AadvGTEL3//yPNrKzOkXr2e7iQgKpstR+gXurrwAGgwypFDYi4MCljBDNtKao5ZY5Ki
7hzlGOn1p8pvvmhh9TL21s6Kerfp6mfAhKGfj57k3P45kVq2R2LzYr6PE2enpuZjlNU/S908MRD+
+ht7/O/vE9ljQ5BNaATU+pO+UE1BR7/Vy7imgvR9LK4tNo6s+eUeQwpsjmM59SdLsn4hs7XJxiku
aiBuMUWMJYKlH/MqoRlXRTZ0tdTDeQCT/WRUn+wuu6+q1rXgyd5Pzbi/vWcr1mGhOcNgg35Bn6YQ
EjQqc2ROHw0nvwaVt+nmH4NdWbuoTh7GZvjntrC1/ftV3bBgy6CxRVCgQC3DpDOppVhuPT07xYal
W3mDWAcfpr2AhIb4okIrX8Z6Y3enuYSw6DhIe30r57i2XSrcsqT3af/nol1qgKaVrZ0paX+aJsWz
wuy1i4FtmNOPY7FVxlgVZQIBCK6KStpWuNBxI9mNOWf9Kdbjr9Uc7ds4/WyP9n3baRsO1uq58G7T
BQqRCd765aoCCgOA8839qSlT91Dyr9vnvhaBaPR/EQMsU/jk7S4FOPBcQCk7DEBA64ord8OHUa4+
KFpwT3Q1PxCQHHsleTFi7W5Ks98wC0xgM+Nk0LPF23EpPCnSgX6LDjoY9dU0Psa724tb0zoqcdTS
iUFBOBUsO0Nlcp0N03BqpBqYz++y7vnxRhFy7YBwuRmUxYovM7+XS+jrJp/IovWnoDX3PyQKSrfX
sKZr598XHr9yJnvsMIVJgjB+gKQelrHk+5D0nx26NW6LWl0KE1TEoYBEMMhwuZSi7FJA9+IBNLrv
fXKvhne3v796HJSClpotKGjiIxX5yigz/c0N7Z7V+kmLvK75DYVaqk3/I0J8Z6Swrp0pQUTuxK4e
Zu4WWdfacdAuD/7cMpODTgl7NEmKNLYgphv+0c5eJvVl6O7ljUu/tlFgJy8go4tHdXXpE7MbR8iL
Tp36qlavTXQHJcnts1g7a6w86L8LDRjV/8t1KPVUFZHRTCcpepN23fjp9ufXCr2ET9jjpTp3Td02
ao0MVEAln2aryr4ONIHvU90K7oKo0ly5nfMDlafpsZ0Tcz+A4LvP8rp6rUdH2bg/KwvVIc4mVFzY
ra6I5XNYDIGWArBSmchyO62b1Yfba12OXHAMLiQIRgxSusE2RyRU9RG860D65CvPCS5O52bJ87DF
DboyoUOv+9mKBBUMgfq0QN0DXi1odu30Rc60o8XUbOJDc3CEWYXZ249BOx27PNhV2iEKm11g+iAe
3AX9eJenp0Le6vlZuRZEMfjPNu0KYNgIltay80KP5JIXUS2eM6u4b82vlQ+O7Jj+cXu3184TL50G
X95elYn7S8VFr2Qj031S5HW/M7KDHm2hsq3cPpYCtya1F7ADxNc9dDSGuSx8lUCyd5X6IZVe5Lp4
v1oCVbzcDCKahXPtchmD1uAsNVQYx/h76hb913fv0sXnBZ2Mx9yKrTTq6ewLds1dAZLT+wXgbDEr
vrjcV91X9diPRlQ47QnA2fioTP/x84u+nUWUVjxpUVXy+QAScNnrjS3emxU1gqr1398v7H9ampFV
pn57imbbnb7N8VaJekWLaDWhNrGAooLwKgiQdVJUA0gJjNnuRhsUlKd23EhPr4qAApN6GgNKRK6X
mzSNWjFMCUFfXUZ3OXZ1Hg7Fb9SM6JfBP1yoCRZadkFIFFmREQXjqTJ2zNdvDYevncP55wX3KQBK
aJodaTgpwb7Id79zzejeAOhnaaO6QnxJe6uTBzXBwWzLvcKfDX9j7QgW1k4FHxNTIWZwrLCYadWE
6QAKmDZwm2w3vx8DYIk4iTaA71wyOMIp9+HoJ9YvGjxDcQ/UQt7v9ZkEzhb1uiW5IqJE9nagd73Z
jid13HUSLOsbWrqYGuF5ZCKbii+ckgAMWIsGnF1lQkIzHlNO2A8+zCS/S63eadEHu3iKGcRNxo2C
+spLdCFO2C7yxfPY+JCaRfPuh/y96d3S/J0dA8OcR5ga19UMaNrXvQzY/HBq0+Oc3YVvt03rij/B
VDS3jSlTh7hIeN/bPgcsIYe0MhgVCU5uzbpPQrv5W51LfQeGgwTU4JQFT8FcmIc5qcJ3RzSk2Yhn
kL5AlomxeuJImj8uuZoh+htA2tF4f6P2pQDhiLKubQ0Ay0kGvU7qUzg+3N6/a5PC521KnWTveZwc
waTkioL3mRDGWAO1Tf2LusXft/y+S42+FCDESV2fGYMPdPdJr+E8ONSxN6p3v7MGEw996dC9ykkO
UVjZLaQ5p6R6CSRvCz5qbQWk6YmTgNOis1Uw6pJutEPWF/0p06PnsQdrEHc9Im/2fl4xcgqLKuuM
mGFmhLOoa1rEjbrpTplcHKwsupP5M05bCZmVIwe3D55fAktMjSW4CyBxRjmoW+2p9UxmJFV5K7m0
JUB4zdtYlXM91RAwAKBp+26obZjJX0GdoFX4CSS48UugkhMdhj5ow7pzEBEX4WEyXkvjc9r8Ywxf
s+le1js3aCsXDrVd2aRuN9X7ya8P6fsb3/BY6BdTyCYv/UjapbEmAZVLC/evJ1WDa9vVzjQ2eitW
VI+IFgh085d9E50WCL2bsetay1NLzdW6+pAX6kcjzffvvkCktZg+wG9hMlhciDx0jl6mleWB6rhT
Mlibxvbdz8ACugdYFp1VPAJih6vu203oO7HtZWbpFpm2S+WNyt2K1uFak1VCDNO5hnB7tMgZZEmJ
nAX/YxnM6t9v6S++LxgySyp8w+ljx9OnXZvumy/vP4Pzny8oUyRb/TC1fH4od2OW7yJ7q89kdYMA
22PCgM5prP2lulZBO5QpeBNenWW7LKODdmsae0uC8FbV9VQMlYqEMH+d/yDMvr1F184RbyzAkHTL
UD4jTBAWoJZNbvshn6/jD5MuJW4VOb1rSuZfkd3d1470APDXbyjuuVBh1+jyZ/K/ThxvrAD4leRd
vjWbs3bJzyUIu9Ymaj05BhLm9BjEu6h5iN7vtlKDWQZ9VYISUrzC3RjDOGkaSvgefAquIdO6/+5E
A+eCMQYtUoHBTuSOd7QC76jzLQ8apfFzu8WEfu2nXn5eeFFKY5gNtefzOXhVNBaFxrGsHhL7/WfN
eCpYJQsik4NfealgUaBp6aBnvicXoAi8GPn32wq8cj8uvi8ocDHndJKT3fNmbedUR+398SERDT3+
pHpI7Fz1x+r5zEs0175njR9jN4tfb//8FUW9+LywPXFAFiPv+TyoXl3n2vP+/TTilwsQNijtjVSf
OyQwndQd0vcP7fB53AZyDSgrE5uX59uTKYtzq/V552T3QU+2iGNW1JRyKl7iMvQKdrRwzexIkv18
rCXsX167eQCrUJGfmlZzqQ5tFAlXZdFDsLym1CLFpjTFjFLQjQbcXedH030ztE+9+k3aaodZ01ge
7f+VIiY0VBhwhiZDymxne7N3KEe/PwBhJm25dNh2IhHBvo5MLkVaN/je3sy6nd1ukZ2ur+Df7wvW
dSpDQw7t3gc1K3SDJ23+jQcCGnQCKKizFvUSIlCaLaWkZ07Jy6Xvdvg92r//0p193haiD73RG39I
MN3K+JQaPwLjhypteNNrW0RVg7wkEwm0RAhbBJZo2Wh96YPmXRyVWf4QFMrn26tYDLTgry/gu+R8
eLrpFl5+wlleQ02tSs1Dx/GqhLm82Qp2makcjMK5s9TgSG9ltrstcO168AyRUyTm549wKvC2G0Gv
sCZF0nfNkLi2loA7darCDbdzdWX/ChJrQ3M2pl0/IkiKPqrDa1g0e60tATZ1PMnfMvDrq3KMX5g6
zHAKq1JNqZh0BWXW2oN56O/T+Wmyft7euTVtwIemwAwHFq2KgsJV8IKC4I8TN6cxGRu3pL/1toSV
LQPaAndkSZNeDwx1vhbLUlqYnma/xdV9BWR+GH6Npcg1ig1RK4tBFJwuVECIqcUm/qJL7KDOe9Pr
PtjqJ6P7dnslK+exYIoTPNGVBoCieHMqWwriX4wrmrKPsr+yvHi0h5PTb5Fh/VIj4QIBNbw8vwr9
o0gULhDMN6ldDqY39sXk5nP8lIT5Y2ea+zAZf4zDIMO+pL2pxrAfzPzw/mUyVk0Oz17o7MTW8SBP
JzVqQ8vrx/wx1O/DF6c4BpnzfjsEVR7p58X9us4PM6Wg112BmE65Cw7dFsfo6h6ef385zTMjZAwj
GRYffpxazQ/JeGc0DwP0YtNjUZVukJVu3937W9hBiwqIB3cudLkMZ0Lnxixiv2ZRkmc6f9BGNvxx
+3BWbtPFrglODfmwUeo1BIzdtJMT2lZJToVl5NLeyH9/vi1t5UIBd03bnI5tZRRecHFis/ZDxeRC
SZFnSn9W0Va+c205oLcsdDJAdF8xSOf5aBdMNEuAa5pu6b8ZweAaxnhU0vyYJNXx9nLWTudcmqAS
SezbLUGl5AWqAultAMBDkDwBSbmxbWty8AgXeHis3lVqL8tDX05BavbKen7oyuY5AuohSbeq62ub
BxoNA7K8sUzJibbb0YY5qFmOGkFnw+S2RxpkgNmijd4fKtHtTYoLh4F4XLRHkjkkaaNLAEjpFdm2
XeJsmNaVHQPKEdAoIBHoldaXvz+7N52TWlGhZ44XpHvDgTP3oEx3tw9/RZcvRAiHb+WVakRlTkbn
NTShydnQrZXPA0i1YGBQJ7pGIpLnStK7wrY90GIf6qI8ZFm4kR9c3nvBuFCuo9CFa0WzungKM67n
2IcENI4u7Rz9rTRfC/OoOQxg/uk3L83mYNTams4FLn9/dipRMY/QYyOw/doE6Y43YEOvVo7dYdhu
GVACae2qTBsQ6JdymwNUAkiQdO8krqR9evex03kPaiDlNZs+N8GJ6od4yAdNA2jjcbbo+7i//fmV
OwgGJX4uHgf4EGJHBFFfNgetEpzGOtd2XWu7VTjel/1PSYP1rTPmz7flrR3JksVfxvuADhGrBpUy
NiMtQ+FpsJ9guFIffuPzwJEss3ZYShFnm6JwNOpdHZ4s6++xjV1n4+evHTjf/b/vC0mFyc+yoPfL
8JSU/bQzp3If+f1BbvUt+r0tQYIHVeQguFQZC6Ew2Ka7LN01/UbQscIaxQAfWTZYS8G7uqpGqrNp
R1YDzE4xBsfGKp+h8b7vRm2f2epzmlupSzlszzBg5cLDeAoVh0zsBIzG7TP7lQkV7cLZ7xCDkjgI
Om3u/eCkW1LjNVpiFIdSU18dx4c8KjWSA0WH8kkfccLt1viaBmb7NIN47pb1pP6Uqy3M+TVDdf6D
BLehWljVrIKN4fE6MorotulnyKyC4KQucHO0+g/zRmC20ua/TFNSMlcgpqNpaLmoZ7aqwJvMLZOL
4XDy4M/8SXuRaynVpxG4DVcv++bOGopyp9hVAM2UU7pqEUH423W9W9XZuJebstpHQRftCWj1fRxH
6ROFpfro6FtDWstTc3VgRMdLW699XYFp4xiYCcDYT4U9vBrp8BEqOS8wkr3jlBuJo9V7cCZKMOFK
H5iJ1MbhqbI0vJ3vIQ1xfrJxE9aM0pKjpyRPNww9g5d7b02zHAzN7HtNru6M9L7Itx6KLQnC4y35
o+HDc+d7fXfqp0Ns/3H7Dm19X9Cetk7iMDX5vvx3Fu+NfuOV2Pq84LVPsgnab83nc590+U4vN2Kp
NYU6PwDhkTObWJYzW/G9wXxq0gkuRX+XxK+pvoUrs/bcgWFBMpWeUWoMy0LPblnux2Wm2r7vGf4H
yXkYlHhvdwqcxgDIb+G/rMpCo5grIc1KY+elrEgbZfLPusSiwg9OyJxO+Vq2E5x8ykF9P3/JMmJM
OWNp0wQNX9jBskplB1MpeSCaHco4O5S6/yUspJ9DUN3d1rXVwyKaAiLdAWhATMBFfdXl8AmRl26i
nRY8q810UIPnlKHU/yZIuDSDAeqrNiNITR8jBpnT9qEwWvglNmzvmo1x6Dild52Gx6sosdTbQXd6
krqzFD6UWfwBus37Zgo2SrIrjdP0nZ7JERRi6AhRfEjhKXg4n8Mk+j5EUCJ2qnPQsvmDFKm7AvKb
otGOrSzftVr29fZ+rikk52bBxsXpXc3UB4aU5lQa8L+T3s3LwZXKxB2kt5TUXL7htv7K9IpvxLkw
YbGFObaFOpm+F+TQA6W6HvCUWz/L2O4eNb+P7qqyNXdaFck7SVMYG8tBP7t36sV8oVGu2rewgdPi
crAmtfgZhdYXScmebN/kRZ6bZ99UM9eZUvXZUChww+AZH9tUMtxeZoa9YMBnJ+EnuMbcOvsM/wHG
kjz4aCaJ/1A2tfOUTbm5czLAyhiAdnZ50vj3tex3OD26/xLmMdg9k+I8OUH2vUzG+un/kXZlvXHj
SvcXEdBCidKrpF68y3ac2HkRkkxCidp3ib/+O3JwZ9psoYXkw1zMy1x0mVSxWKw6dY4EuCkA0Yk4
jBN1/HRKx6u6oOX9bA/tLio6w3dyO7pr0uzX1Cf7Pun73LPGvPE1YQ/3pGsrv0ln5oFzIvLmou2u
jB5NCkC76Tx5eXYjpDtAknw2/TJC15Dbgu9KyvNjOiSvM+niALpx+INt+R2pUuPlyUweIhCJ7qWk
rje0Y3ygMsforDmNv6zEGYPLLnR2VDDoBwQZ6AsBvwDdhPJkF6hgW72N54IV37rFZ2L7WfLjsokz
L1VMKMlXEtWNGEuNg6AJDKztP33cBwyscslrQtlGhFldDmIzase4FM5epAwkBJHWtTwsdbAgFNfG
/KuLfv3Fek5sKFdOBay8ZZY9D7uJBPkMWvTxe9lUXjvcTOYW9nl1QcusF9J5jEWpzysDwHCHgVM4
hFpHwI2vY27say36i22DtAQGwhdaszMSQ8gwOaB/wc3m6OTApysLVDAm27hm1pZyasT8eH1KnsS0
EzDS5NwH9eD3Npm+aVO88WJU3A0UGQsvIjzawfTu+SDZCN1Y0iXUCaE85sfDDZWjN9FHjf6q4g3P
Vlb02xTkuDAWhyHGM7iva0qe213qgJkj6NvaA24uZZ8ue9u6DRQjsaSVSlcJeZmodgondHrmc3fa
5/WD1W5BD1Y3DQNGKBgttQ/VzZYwOUIVzwlN2UAngx4jTu9R99njVsMcMiMb+ad6df7eumUk5D3h
OJupkE5CW4P3TqiV5OuQmM+gZb6Z0vxxlkbrZXl8V4HtRmvIDvS3T5lbbNzdyyE9uc3O7CsJcFpE
qZZYoxNidut6SPlNZ7E/y4F/mwDGF30ZcCydScKMvJONnkhUw/AKuSau0TxPJXTFazt1rsx4oht7
uuopmILBJAyIds5KlnPulkZt1G7YmneivRf0UeTfLjvj6q6dmFASuAiU0GXNYGJACJrdH9pWRXHV
ACToAA5F+QJTyB9jRGIMA9Vj6oa6dm9BqFbwrRx0y4Ly4SH5TkkNJqTQnPbIRf4QBvj7o2NUBfcP
xNDPANnxNE1uEZfYoXwA9Lv3Ni4ftbby2wDDlDmmPNCRU5P1mZCmHJ3JDcfiYPPr/hcrbqABmThe
M+/G79G8q6D0zgLydvnTL+8N9cCgAbegGxHpzqYnDEcaXVk7Tphp93n02bA+USjz1iCDncvXUX7v
t47P8iHODGKGH2qH8OgzPcWYuKU25cINC5EDmBbdGiS/LnNn8swGl26XRtaORH+I13jfXmgs/Wt1
cZ+T96QL4e+8JdwNpxxkm3P/2leb9bHVrVyUjTGQANiJitMpIiqSHISQIcBGfhqNXpILj8i3vHvs
6VPfimCe/uKmwvARKtuQXFz0KT8uawSrBKtjC7dIcUNxuTdXWba77CBr4efEhJpJ1l075hUmrEIu
xHe3158bzZVg4GbhZTtrV9U7QA7lc0Cd1PFFK09olQKCi5GH6odpVVfFkMY+cqefugAcM6qodrhs
cdUT0T5Dm31Rx1SneirwCsD9ByeMWDTt3KGbAxczBTszFrmvdZ22A581WCXoJlfP2loxWmzi4AGa
ZKntziiro9mYaPwYoYVj+FMcdNYBnBJsSy58LSouIvEoNSDNOOt7JBLUN0k7xY+N+Nrrv+YtssG1
3wfVA6aWsH9Iy5W4LodOi4aqiR8Nxx/Nm012ntXff++kotOFiQ8ltywcq4WKZRI/0vKGZIG7NUa0
XGxKMFqG7JEio+yDIrHyhhHaaPKh5iwcMJXLoZE76daumB435wRXDS1DZC4CLchyllN2En+GjjR6
PYx2GEGmBo+YK6hUX/X0NsuCy069smOYUkNKiY8Bznd1xxKgHbRS66ywF2h0d3h5bwG+VwIChoxR
J2NQioYN5aZtuFWOUhhWCKLysDbTTyNpPnXZlszH6kKANl1OCfIedUhhomkPRBezQjHeNOaVsQXl
Wvt9HA1Ql2FCfumff/wiSa3nRTslVjiYQTofyu758odYiS5Lcvjv7yuuK3haGZbE72uYCP2at+mu
bcTOQSEJ/Lye027UxlaXg8wKZ325xVWCo86wU+kIl4b0EPFjkW7EyncHVU/KMktrouu8gCiU5RCI
hlUVH2moy1y7nyLpvjlF1kKHtx6ueYkQxkYolDsFnk1mXmh+gtk2yKPL5OD0DjKKBvKMtWtPt+5Y
bM3jr8RTtIEwYwIeSlywqtMbWmkQVvc0lNqX2ah3lKHGUn838HqHvtLGVqztNEZBcYgX6gYg0z86
DkCHPdNGSUGs/eCwq+kPKUCWVIXhrY6bAeSqKPMpMbXN4pwTA45DquSlScf7TBv+rC7wbgIT76g+
AFAM2NeyxJNoBAhGrUnW0ZCPzjPS5qPFyzJgJLL8y4dg7cOg9AfABaA3oB1Swl6eaaKK7IKGJiqZ
MOJZWe03eFbrCSCaIrhsbS3Ior2P0AcQ0TmgTGboduVzTkODgKqlCMySew59kcZfHG28xDQoEKG4
dqYU4DhFS3lcW6HhPscs9wztTmovKb0tyU2/laCvhdtF8wRY36UfouYK4IQqbai0WyEgS4NPtLwO
rARkVHYNEtnL+7fm2aemlJDoRMBWlnmKkDs90+rJtbc6yKvugM4d1GKQkpzleJihB5l7gyA1Zg5O
qTMnQVZp85VgutgNg8Vu47hxNs7rqlEwXqEIgjmVM9ZdO896ZwIcKARRbhBlfJfiWUWd2654isWP
yzu4FvRtrAzpEKpHEHj4eLCsZZYobR0rLIziF9Qi/YIVV0Ojf6ZO920ei09RbWwx/605CJo7qKyh
V8Awe/nRJjG6GUANeGMZj36dh7pxNNkfzvK9Rwwg9KBUiDF+RD3lIBdRXvCxtmjYFvcVkID2Vmdx
dRUo7lnoiSEhVu+vfmGomjijYWUEWrmvDS9x95c/zsr7bCH6+NeEEvWEnjRMWpSGPam8GfBgkrBg
aH8N7H4ovg0AJIMy/7JJY6mzq9fmcngXBgokTSpXUZX0bZ+7uDYBie4eJGBV16AXtw9Ur2lgVeXk
2TafoIgtNV8OdnvTOH1735Sz4cep+FmxagpTHrR2vC8B9kLhJGIHyO1iSA39UQA/HMwob9wOawcG
R9HEVYq74WwKllqD2bBx+ZuhcoMXuXmELHHMvIFuxOu1eANoEQDnkN44f53QQRRjGiNec5D+ipzm
HvAvW0pea5fC6XWqpKtxPGkdaSMapo0hPXcg+9jG4UcKu+PDFqmzCgb+fXm/T0MaqKRTNTmA3FIW
ccyTh7zlNkiAssAk3U0sit3Ym19JZt4leb0ziuRzL4sN2N7qShEG8GzFdYtT+jEQVDIn+thosF12
TdA0UwuRIiTQIJUb91Y21xvBbu3IvndkAKcF5N5RAk9l0a7LKslCAoqCnpuHcQbjsDsdLp+hNS+B
k7iQ/MZQNIaJPy4rKQtTb+2WhXYNKp277PEvfh6kGKBlB9ANXYSPPz/VJoszACFBZXuog4JfXf55
leb73SMwnPLv7yu7pMuWpVTg97PcyiyPNiIPazkDISV0KrwqicxDq814micxFMbbSBN45+aRN7KY
+LWWZ4fMyOM9AwOJn4JXAYL24/BqN414dMtZ+G1TQN1nLt0jr1GcNN3KeSuzONpYyNrVhnEqZHNI
D0HNrJSaDI5m6EKJELbjLi8CCK69Emhvt34UbaQha358YkmtOAkinFjPWid0a/IYR/YzmCuPXJoP
wpj/ufx1tkwpuTwzIxKneeWAOhvqV5kVgEoGEhwo3c3fL1ta9eL/ts9Uciu9MCZSisYJ0e+DUiXZ
qn+vrgT54dIegw6LWsyai6E20cFEe0xY1zUDwyvb9Z11N/Gtua5VRzixpB4YOzG1yYCltvtWFLo3
uD8cOgW1JT2z/Uds1R9XN+7EnHJ+MJldglgiQ4HaNryMLVfg8fKnWY1jJxaUuGlpUT6DsdCBttxx
tvfG+CXbigJbi1AODxezaHBpO2E+PrHuO6UbMXJjCSpCH+zGA4tjbFLlvkzWVy2hHttUkFZxqL9D
2X8bpYJ287pxmhYiqKHZTkhHqhdK5atwmtuh1J81p3umTv2zisjBtJIdbdldaWxpNq0vdKmaLmNX
Z2WIbORF5xgTCyvu3ouaHbjL36pxa+R2y8zyPU8eyDyNTdqSmYWd29+mrvEDlN5oKxkbrcRVM+jM
v7dngehX3EJ3p8pwSM/ChEP74GvFf2Vbo7arcQET9EtDFqyimnJ8RMwKOx64E8bkziprz7aE54hP
Rvbp8iFa6/yi7vSfIeUUpVUPdFZFWBiBGKVuJx9DUcBCP9QYwDPmLzx/7Hogasriat7CS61uIzhY
8d5CVR0F/Y9fy471tK+SxAmL6E7mVwn1xRa79+oBPjGhOISRYjK67GACYB5rOIDU+/L2rf/+0uLF
ANQ5n5WZSVFwzuAJEXurxPDFMKPdZRPrXwjDA++NZBBbKdtktXGlm5lhQ+DwjfN4Aqys7vy2wFCP
nbQ7EEJ5MZsf8pJcDbLbTzL9fPkvWPVFcB5hfUsaoYoFZkaCcWdLsLCvvdoK7NcMLc1yI3tYzoz6
4sJb/18jypUeVVrBCIWR0dCqONCG6ntHaPGl7Nj4RFyt/1ZIPu7E3HZeIiK5kYSvFkoRn0DggzoH
moDKgcuaFIWtvGKhPtnXcZke2KAHXdT7utF8ArL8MMfzj4qLf8ypvbJZ8iiy4drJh8fBGK7z3vl1
ec8Xc+fbYYPoAp13nI7l7JxEsnHksh/KyA4l6aGNHnfDLS+TPNREOz+1sUsPHNoEf/GChMoRHkAL
r+1Zt5xAvkGbtJSFDgCh5o1TB2jlUXqU2cbVvfaxEdMwGIGuOQCTikuLtCgy/BF2aCC98hK72mcW
eJpEMTzJQWo7IBL3XO+P8aQ//fm+Ag2w4ETRQDpjHuKuk2iNROeoK7529EfV3tl9vbfd47xFdbYW
Gk4tKZmjkFFt1zOxwzQ/mJEvWXB5JfrasVymGVCnhR0ATT66iBZlUma9bocsqzCuCuYEKLLOTb1r
krb6JuP6M+781DNqrd2NsZZdV3mc3Y4WYNL9OAxXQP3PxzoxK38ms72rM3vjibbyB+JALbW7pcZ/
Vq52RxcJhzGjqlYJf8Qs6mBVPjV+gARsYy9W9tpBKXBhKwBaDkW8j1uRFiO1US600E//LLRHdyNN
2/h5NQCOdV6MRo2fF1qKMrjtaRtTGGsGMHuG19M7Slrt0tit0Q1zP5qY0Gkcv0Vv82DNabdhZe2+
PXEY9YFmx4LYRo9TN5viuitL3yow4mP/xZV4akUJ5HGqpwSNErRMc3TnAnOrMLS6CiRduHHByXNG
I445Uy2KTSRfmNb92tLoOrLL16jbKgmtBWDcuCALwMQp2szKMjLg+0AlhYzVtcogB7I4hoBdY0c/
9GJ8NZuq3Yi9Ky7ATu0p4YJ1rtWRSUcVSGpBlJf3Uf0XwAmM4FhoTQGjqsHYx1OCAnEHklrHxinx
RRS09X60d2npLYTyW+/a1a90YmuJDSf31wAS4tkqcH9V4GWyy2+2XvvG1vNpJcAAeoUzD5IjPCxU
JgKaOlHOE5SYSHUFQLc3Fc2xFsQzh+zqcrBdXQ5wZNg7zGScBZhcduMM6koWlub0o5rRo5LsGV32
jUCzYUYNNKCMFlPdwIxO57CmyRGdxp1pbyX9q74G3dd38JiOmZaPHycpALdPTCBo9Gj6ybPy1sjo
BqBz9ficmFB8re4KsC/Xi4nBMyzfSXeE3DaTX2019VYNIf9c0FuMQevj41o4KkAcRTUUUDA9mYJC
uMkeqzjzJodfU7GllbPqcWjuolsP2kJ0bz5aMw3IYrR8xoO9PFL383yTZI/GlnDJihcsDKPoCWES
FtC3ZcknZ8etGl2vlkpNnj1nxYhRDdQfxUbCu2VEWYnG037IBEobRpxjpuEwD8Ayuxt53oqjQaMX
1Vm08VDMUFOU3C4co61cBFFteJndNrCyeEudc8OGeqtFXOpTIx0WTkX0DO7+WyeVL5dP/8pXxzIW
2k00oYDWU/bKTize0wZ7lcUvRvG5Y89d8Tl5vmxkdR0g2AFfNZqdtloJJHbTCxdzq+GEE2P6xp9f
yw6AAwtIAYH+jA2Oc0AHnKHB5T+BPiEo7Y2ayHLOlAfLh99X7q9aL8cK0Bw7HKpyX7D8BsMyTxPk
NwfTviOO/OYY6RsktzfMrn0aAI0gxcGANqIqJdkQz9OI3pu9qHV70Ogy2z160jXd8ICVKIMrBjTf
GMnAm0wFdyR6GtVtJWwUArUrFHOpZ6Onoc/93oy7oymrDVTlWnK/3GkQLgLHMHSHl+N7EgPqONV6
4pRLFmU8UeMLhiX4rZ3JoGZ2/BRpPL7ushi89W6v+SLXwzxP9xB2L3cxzbRvfarlV5RaW4dtLWoA
j/suv4ANd5Wbw2j6uoJIMh5u9g2J3iZIJIBsZiMVWt1skD4seG0cOFcJ6bEwhQGUix1CqDLxuJkd
pJa9yIJ9xle4ttDYvHzyVl33X3uY7Pm411XtlFJUyIt4ihc9BlbBtJ76gvmzI7xk8EHSctng2lE3
UNl7Z4gDlFOJJzmCftKxCU9DFpitVzz9/35e2b+pS1mhafh5q3+drjX2Nz+Pi5YCgQvaHRUsAb2S
odEIfj5nN255j/bvX/z5J7+vXH8jXq9zG+H3sytD39fJ/vLPr33t01epUnuYa4sI1BissM3yzmtt
J0hk+wZlwF0xDqBUJj91J7V8Mmw9jNZCFc6ztlzpKDOp5c4u5ig8VMQMjfyQyf1YH432iEbg5eWt
WsFcALDfgMieUYPpTj9Cya00wgp1wclkV05ucEiwtgEu+61wsDiqGvTxakGBCriZJZ38eHIEENcT
mTsDUiYmx+TBeJ2b7Evdl28NQOEeRLO516BudnmJa18QrVkNgEFd04F0+Gg1TykHzHQyAW2vbmrg
NJ0KIwmm+DYPZPT7pHw1QcTv9RmErC5bXju4QI+hCIvxr/PRbBnLdLZbboZa33+Kc/cmlflG5F+L
sKjHQ0YHvMZ4fCqLK5KpzmInNsOiPUKc2ItI0Mdvl5ex9tkWrCl65y6AR2paNiTuQsVXArTDUVTE
wCS46tw68ozCLn4Z3ZQeszHmQVSa2u6y5dXV4eEBf0GcPUtti7K1zErDGdDbafhaOc302ansLKiM
UW4chFVT78Ah5Oug5VOiYCbt2WCkpmGUlncYqDymenwdleLPAbwLfAv4pHczagsPDfypqeIGZvJD
XfjpFtff+jLgBxj2WcQzlSOmC9aWk43fl81dPV/30TdHf/mLjwJKaJQFMNUAtPDH8+SQImlL5J7h
UDafLToe3ST6p+6d/58ZlYZGos0djY1t4t4w66A0Ync/44ZBzTK2N16fq5v234reWyon2VNsa72M
C8cMq86PrRgV5sRj9oaDraUpgH/9b9ve264nRlp0rxJt5oBWJ3ZteCh4kCP0u+hubvvU13LgeEZz
E2a8tjSU6BdmCPS1gOj4+LFkG2ULPp1Cr3xHQL7I70S68VRYNQHIDiygtgKK+I8mqn5O6ARh4tCQ
2esY1fdmlu8ssaV8vWVmuclO9g9T7nlsgVE9nElef0oTmgRWnpO3Uer9bsPDDfyWelGBsBIFQ4RU
7YyLedKh9GbG3AoZJoq8IaHDvhWQja6ZlfVewgWk1+Q878uiLgOnjWy/qsjkt9GQ4mDPAPCmXXrs
GMl3E9et3hs1LTu0/QRq8FJrr51Zrz1hd6MnWZ9c22X9KCrQKWmiSfddbkVHsImD6yg1MU1WLup2
mCeZbR3hvbF/RK1ZFguTQuSPY2l7qAdnnjuOvT/GBv9JcgOwylL7ahGNvOKFYuxIPLe37Qy+ZA8Y
ArqPaKLv0D/TvdTSzGcr4ronkjgJaDF0V41VJnttiLZqpGu5BgITug8AmKKDqzhKWSfQY+5ciue9
G5hm7ukQCyV4hfF0i+Bn1VlOTCnOEvOY1u4YWyF3/cy+a/DO2RLwWDvPKIoC8QVlB0y7KmEwE64U
GUOkLYfudilgV2XEd0NpPRSDQ/eF5WyUYNayCZxjNI81KIAj9H48AD3teNsTaoYoBX1jbN6jOLLR
glndthMTyra5CY+GITORTeh6MOvWkzvpxwV4dvl8rSUUoNDDFQgyy3MtBlmmEyl6ZobTmH/u9Opa
NvJgQyHHs+Mq6Hifelm6BT1e3T54O0qykEShatNHEm6AtgNpoJ0/QQjA6jf2buX3F9ltaKBBQBi5
kvJ5stmyoOtcmeFsY0rOSbwm2uLNXDlASCY1C4NM+PsxBvTRA8op6kk54Z6C/NoPbnTac2/moIas
CN3RUbc3GkCrK0J/G9CVhQdbzS3B6DZM/YD5EWaKXWRYQT1sZK+rCzqxsPwFJzF9JJl0xwwW+jh6
Kiz32JP4pumlz/piKzNaXQ0k7UFEiKcOxpI/2nJJ2cslYwoZGNoY2UXWlkLAyunBdfCvBTW3S+0Z
nUsD2eosom/cBgx0GqsvzoQod/n8rBrCODAAuUjCzuYlAbYemyyKzHDsqp8k0mPIKYCgPjeaLUvL
pigXIWC//1lSPlCFGURpzPA48tqJHf3cCuyd34ugKnZy3ijOrS4LrovYtmCAVc49h5WYD5DIkGjb
faYi3Tl5AbSxc7y8e+86eOqiwJXDgMGBYOEZXQY1ZNMl9miAAkbLvFnLUZenuYWpvbYPk86ygqLs
Nc9tpfmEudr+k6VNs2ciT+s8u4EYdGSzGrW0jji3RKTJEdx+KcA10bA3rG56zZzJ9ifROrdm1bRX
tkPKT5pppL7Oo+oZHy+9ySUCLE1ay5/NOj52Q6SDc3fO831W2+OxHrsobEQl7lhVMJ/F1D7mTdc8
WKTJQIEUxcGcHmXXXzUYznN44GQBRtFB/pIFk+4nxJ94FBS2cyN4Te9wl6MglldNAGrM7ikGG6hf
Eq250Z3BegQfCf+FHMbZWa5o96D7kXtRj3NQWbH11La8CHq7TnyMPbBfc8kSUKYJwzOqHtrytJ12
ZuRkezQEkqcpMc1rNzKaoBs0ufHdFPfAmAJuixOaG8UXSTLISkM55qFyXuY0LOV9vqUnsW4C+TL0
wRbZCiVGDKA3NKoJ/NFDNQjgHPqjPg1Ab/+5KOqyFqjBAWS9aH2qqRA1+YSgC7EP+zBZnwv962UX
V+Lq760CPQGYtlG9P5Njr0Zid0lPsI7Zvcc78cgT8zqZgZMa6cazZnXLUMpZOlBLHUB5YIB03p6G
yCYPmv5mx/9EDCicP3ue/V7NAmxCpwO1MPVNG0O3oIuNhofgPoiQoxo7Xu0ub9jqKjBViiYduk9o
1n28HOpap1PcmOQBVfv4aubNdLCHKToUbb3FbqkkP8tqMEi/yEvYgJKe1fUQHEZwccz6g97Pz6mb
W15f8ldZJM8g8/rZSDATTo6+VSVdtQqmX2jOLXNK6qO9wHS0tNJOf6j6eMe1gygmz6o/i2hXyxsZ
b6EulOT49yIx/Qf43zLSpYZyy4k4GUpXe4jKX7xgXpNg0gED0Sa7qact/ivlkvptDFf3okC3HCnl
1EYYq7B7UegPAPZEN8wED+KcDNkes/iQpidiNxfM2tEcr3ogBnnwx66DPs/CKLlQF1hq3jdlcTOm
XOgPg975mvHaNE9RTDZufHXi6H2N4AnEIx6z2WDrVhwUpcvYTVpdf3CMx1gaXj9e4yXp8WEvWMCj
XZWC7vr75ZWdRRHU+wBn0ZAywT7+rRyKXiuEIA5YUgePyse9PxgbcWrt2C0pM7opBhii1eqEGYH0
r+9AmueQcESBr/qZ98+XF6GkfcvGvWfl/zOh3hoOFNJaXZKHLPNLiU7Nxq209fvLEk9SWDpDeSix
8PvkebopN/Lj1R9HVIJGCChQzt4sC9/abLoRgmsS957MGFqjzcYGqb3D3zsEXhSgRzG9De3gjyuQ
EcoHXQWSOlRxRqR3cbFH8IqunZ5Cw4WPkCVyxsyDulLll7mY94VmNIdUE8K39Cr5oVWdHphJ7u4s
maazR2r3Dyf/z/7EJbqdbLI5YNC2aTMeDm79oxZtt6v7+ZER/U7WjZ8U/Z+9fM7sKRHF1sB8oKcJ
D1kSY4A59pPxx2W3XAmQUFmD8gtEWcATYinXplEBXFfFuKFt+8vsan6X31gQ5paYx96aTl11ov9I
ItVCBdgcklw6Iw8jMb9kOX2uybi/vJr3+/EkpV42DE9eiE8vrPgY2FBOQReBvzTLauuBlmm9mxiq
UsQk8S6pO+2Ya60Z9Ln+gvZHM3iske1h6LrCl7JrfzqNMwWA3ev3Lgrjnlux3ks1uzsYTdy8DWbb
PRdNg6mjek7vxhra36A6NJ6MWhZ7neNYaHOOK62eksdmtt+muc6PE5sMX9P6YV8yLfdZNQ9ZUGZJ
ubMbLd4TmU67tgbozMvcgfsTko6HSBL7uW+Y8Gu92pKwOgulyv4s//3EgXlnajFqX9aD0M2g1fdx
6ds5OC5d//KHWAmoQDeY+AePQ9QtlbOc9dRFg0F3HiznWOo3JY5yvPGtV5bywYRyFiv4c56VMEF0
IOd8e7qO5yvyz+V1rBrBdYpiB6gesP0f90vIKk3HZHAenPSZ6kdR+2UK14g3rtWVzAH9i//MLEfn
5LN0dSx7LYOZzMoDENPq5s94DKb6oapmL6/fnHKjhqcOVy0H5YNF5aBkBiFlW3bOQ5S5vuwcnwlI
mUXJrnNLL8pvjHm/kGgY+vcp3/X21eVtXXMP9ECX+hF4Os7Erqea8cogmfNQJ9bNVNs3UdJ+Qq0q
uGxmLVuhOkZPMB2NUtsZbD5uZpoyAnHjtC59d9oBDeMRjKJYpESJ75uRXhfU8iBKf9nu6vJOzBof
P2eeStTPge95YOWnoTmI2He3JNu3TCiOmciEJL2sIUXMyx/mnH7Hs3c35VuYljX/P91AxTH7vC2Z
zrGB5vSlzI71wkusHUZz9+cbhp7NQh0MsBeaHR83jCVGBfSEwR6AKfIq42lIPmUAK102srYWtCMR
NECseH7VaQjjLJ6gMUUHc1fMrm9Kw6/yb22ysZp3KIlyC+HqgcwYWHvAWqXCrtAd6guhcQjJtjkm
m4TD/ErK4cXMXQh920nzymhC9pGuzV43JRiXj8CiJIraPcxtDqghFhDvI0LM6zEp6quCV5Xfm0zs
UApJr0WTFdd2AgGKkVDDl4Y5v1l2Ofl2XWkeNM7GoJ9aG8UTB+N3gzYWIAGzRPPUDdL+KbKyvpms
zNmDZzjdtxVFesGEFbR95NzGCZkDy0mavSjZdK9LkVzNrsDd1PbJfTdD6BD6r6VXtTa5E03vbByd
lffhh61TojqVDZGE4CPV4wttDrS9RevV69vrSj6O+f4vPGLh9126hTYa4R/dDuX/0ca9bj8MogR9
4jEvv2GB3rg1vbOckjN/AJ4UnCmoX5/RL6MS3AjRUvtBWqUf61/dfOtZvWZhqY0vej0G6BHUiGP1
Qsw9dx5iv+ljz918SK/FGwqGNxctJhCkqU2fPOohvlDGiNhQHUkByjlqzl98jVMTy/k9uQRNN0X/
YDHR6o8p98A3FIlb/nr5k69uFF2U1Remt7OCl5WJmUqhsYfGeiJRKLaO/sqXRnN7oU7C/87yntFI
EOKGFu5r4oZJ7zmZN6LYSsJOURQEcAmcYBghUDKroemYcPEsenCcwa+G4R9cr1clqJzNGGlkU3Ub
X2XLnnIguyHX+pZCBYFk/b3Z0EPB+yM3wHYfuddl123gUt6f2upZOV2fchU0kctN0szRQ9RVjS9B
OP8YxewnLUlxaOfG3SdN1niRzstAY82vgRRvUVvzo2Sz9VCCEPnlssOsOT66piaiOC4nHLGPXikw
uWhNE8TCLKjak59DfzsNf15XXNgN/zWx+OyJ48ekHViuLXpk7p2pP2XdU+lstDTW3H6Rd1gI+jF7
p3oNqGIhIlYn0QNwWl9BeYGpbJYcL+/U2gMewFfMwgKsjb1S51qYZbeysF3UaRype+jxx/rRTwc7
xoSkOIJx+LrN4KuJOER66lezewWO9V3Poi9ZtjVjs7rgZQxq4aLH1IPiRmNhaoNZZpBBiNGWKkT2
pW23hGzXXMMBbIFqNkKibihBl3RNzWlh4GigHeKVVb2vewp2JaL/xWvKwWgrug6Q58CTSnGQbqqc
JJ7gICy/63Vzr6fZvS23XlS/2WfUw3dqSKnuof2q83fFI3cwk5sayPG94SSghBmjL2hIyL0GDQlB
GvNuMkm9l7MZXXX9UO1kZNn7Im6bnWPVbSD1ofb6KsXLjFo/TMztHEAIxK8LwEwwnQyJDmJE+Q7z
9XQXJzl6/JGLaZG+IbBV2e6bNZagsCncPIjbEhobyOsOGdOSXTX3jdd0GYb+DQBhslovoJAB3Y7C
HYabLJmSK7dzp9JrHGg6sqi0A+g4Nf6Aua59UZXFdcdNd08TOe+neso8s7cKj0yQaW8xSXFIS0Rs
LtrxqMWCeahKyhdnZkighjE9YP7IOgpdj3xbg2DH2HbaE2Vo0UiUo2zQZLFKm++1iBtXpiVfcvy/
7tvBRY+SSXloc/rG7Oy7TCnbY4LYvuGZuKUacLV4a+1IbeYPSeHUh3GcMt+sx8KbKlPzOsmH22QW
5IbLbPYzh1PP6fn8pNXIAauMN35TYTLOZhL/AX2YXRFDHaM34vLFKuIm6PVSQ++szA6QpqU+wTSY
Dxxndw/VcpCDkd7e9Y7Gj9ZUTkHSQKnSHqpPbuqMuifh+Du85XPDH7ve9iHEAc2UtkJLiif8jqVV
EgBQI8FlCx2OzJQ/65lJZCG6thtBJQ8J1KbzihRpLNSXenCfldqOTqCqms042xk5HW7aMdGhpd1D
/8COvvaNbbxEYtCvXRCDuf6ckuFbVwC/FBTEhJBmFr243f+RdmU9kuLM9hchsS+vQC61dZHVVb3M
C+oVDBhsdvPr76FH9+tMF0qrajSjUUs9ItKOcDgcyzllHaL3IcDwz/CbAk83BKQT/Z0N2jdzauuH
ZZ3Y6YOaPA1CK8JumKYIBE8eXmLM2xkOC578YJ8bt1P6ca79AIAV1D0sTp/itwrvjtXOEGP6BPSQ
ARheYhTtnfuyJvSB5voSjQMLQtGxPjZryl5yDI0li1/BGGFK9c2MUxPq06zjKU0QLBsggvS01gwD
d/SMvU50EOi15Ve76n97bUs/+MOA2RnMI/+2eebvbZplB3TbTvdBYfnx0NpsP9sNi6u+FmFle91j
xcFjqJkZ29e8G29JXWEkEgw49c5Fd07sITS465zJvQX5BxY6U4Af6tWvqU2Hwzjl5KQVhEQ1yqov
pjsZgO4tRuT/smzUb7wGELUo0/LQytB9ahRacDSB8ht5S57f0NTwD01nzHFjoPWcs9YGK1eHWfF6
ym+I1bHDuPweB2DKwW47TCfGls0qRRy04eCBOwRqVTB5rrUkySd6i5cCYa0rktbeLeFkKwK5Dd9+
8XnJE2KKZcz1tC2A65CCKq/4UPj6DUbGFffyGtNKDvdCjHSFpPnY9aB4KJJuCf30H0b2OdunqSLo
VUmRYhgioK0g5QVQGW4Bda7Zz023c1V4nqotk8IYw8491gfQCCnTkHEkq+37ToWquJW4wo6hKA6t
I6UjT700HRikgKxdJIIZFU5A7f80CRI5lbOIh6FBJhAHpsz2AQD+omKgemzPQRHTrFRBf2xb4N9f
IplI0DZa1uT4JV4aW2Kn6YrIW/V9yTb6HIPv6LopElPs3BgwN9fDtY3AHjh3KOboeJciVyupa5pK
zSwmqGvuTrR8MIentEwsctNnqvBlQxLgfxFA46jrQGKRYjHgxwGsuWnSx8ZFvyhlwGPp6nyP//l3
k/b3bjv+vL60DXtH4IfOBrRRwUTk/MucDVabtV36yOfgaHEwljZzd2zaFBe4qUKZ3VAThLkAYUFs
BnBJ6XA1wvIbjJaljxg9gANlKqrLze+jdI1p/pWURS6bDG1h1gUBCSK1h53ZGqdO1Kr0wcbRBT/1
+rxBrn6d47wMMD3AaLdBR9zHsjro5FAXO226ua4TlYhVZ2ePnJEPpeYIiBiavV+boZlpYf1mQkrk
0L21L3W1MiTgJJuuEO8ZVk6KJABAxG37xqGJNWkOBa/0BsgYWTBlaQ0m3iyidIqE+hEgkVXNwhua
BncSGioBKoUZExkjHriWC6P+AgdKu3DyUIMSz9eVsCnBwL4A12Rdg7Q/1NByNxcGSbosavPIH97u
stBs8ff7kh3NBus7zIeTxPtc2PtZU9jQhiMBJ7wDtnCMboFCUzpqLGttPFsbgiGx4JYEn8r5e7HM
UY9OSq//8Y6tOpMlbRXiUqcOlo4k817YH3X96frnN5eCXDQuMeTUXuWhZl9DV7JoimSsvBPIC/Ff
mwCI2Grimim0opIlmS2pLZdNeGoAKZ/m6MgrviyjDhK93q0is6ydkBX25+vL2zjt60gCLuj1Xfyq
G0vDgInVi6JI8poc9PRekOaWpF+vC9my5jURpgMZ34QYKQRMPUvoIy73xA4+OBRojYpc1Lovr4Kz
FQcdVxe6Q+R8BgBIrQL5lCJJWw8ttEbY6z+MdNqlgaL9RCVIuun9kfg+oG2hIOOn73+pNTtM22en
UXQTbNgBcKH/rkc6PrRujZrUCCjI8k8D+knWeSEVOZDyT5357bpuNgzgQpZ0fDQfSPKlYRbJwBIr
PYwsIdPhHSIw6LPevCupipSZtPO8t00G9ZfkS28DYg0hrcKMNxWDtiAAU69jmzIaviMABYGoFqe0
rIQV5rTIn3OryJ94R/SYYyZQkQrcMOmLoExyoHa9GN3CR5i09gv0VEutUIvq+5IraKnmLlmL9wYo
qpBFte0yKvG2vK6YNZ57dW7WVjQMaQIeVqYBxDjrkHYjzg2t8NKfo1z7vgzpbmVUBkZUONCfXaEQ
ubkuWDYAIhwDoxWSK2Bm7mSoqpRJBUhi5wQKiOtL2vo+OhmctbUEsawcINEGc3lLGZTgO+HD46Ia
XduyMzTUAZgTUD2v+6tYl/NgzswqaZ1vdhNN+8Dcu+nz9TXIiIxr+IKZGrRwIYuIiW65maEqp9Tk
AlIEUmOgESxit7irsljvYg1NFFO/AIoi6q0pvC54c/N8A/AdYCR6Xf4Cu4nhlNMCueDnfZ5aRVSw
9Xn00BuYd0HQ9AqLOK1qFwhKU5WgdWwu9oR8f/PPR6vsH3w2vDoBQXUZ9YnM6RffIiRJhyf7K+eK
VoyNn3/xeekZiU61eioCfD4HfQyGCfN5iK8vYMMXn0uQ77GG1r0xVVqeuKl927X6x3lCAcBpVQ/i
TTlAGQGLEsI0HP/LjTKtCnwUNiWJ3rVx5/8C+CN5R2c8Wpj+yljvuLNnBC1Gr14qhID93Ib2WGPc
gaHGoLj5N3WCIjsWYhp4HEsXMmtdMuHiJwnnyC1pz3qjqJVsHHi8JdZbBVxwCGglpWeYpMiq1CKJ
4yxom/1d9nxva3ctANuu635LEE4exqPR7A0XI+1X4fS8GQBIktDsMbd+a8PvfvYiGxP6/02OdBmb
rYeehwULsozvdXXbkB/tGHt9p1jOlmLW9mpEe4gqX70A9KHNqL3ggTGZIk6DPGyApP6OlQDmBB2o
eOq9KqUvRtXqbinyhIAYPHR1dvSL+sUCea3G3khutnpkGNlfWVJEZgpOyhYhGK4tMwgDnqUoi2lp
bDrpsru+rK3EGSaafCDzIC0C4k8ptNCqIuudfMwBo+jHYBfdk2b55XfarVk3sZPnv81O381w32Hq
Bbsx1X+VdqoIb7Y8xPlvkDxE3aO5Q/hY72iMbtTW/q4j9Qk57ndkhy8WK5n90i2FnzY6XJ7v3lc9
8jJL52uKLd00Rrxw1p6IdcZX0l69IrEsvZ0n7RB1EXrormtM9fn1789cneeKOctSF4YIgFQ81t9x
rYG/DaVaYBFiHFX69UYwtLqZtXmCif8p1B1yP2WBpljDpvs5EyKtYahbbmAgPE90nljWt9y1Dia4
9Qzz4/W92jQs5BfXto617CPJaXLAHHarnMC7Ef0BxQfUM1TNcFsKwaAMNI0RC1RjJSEe8YO65yXu
Hus3eqwy/W0ABn+8AUoIAUQgF4cBzkuFT0PAugpsFAmpdw3oJ5tdpfICm0s4EyEpPa/pUvUVRAR8
l2WxCtx3Sw1o4APDDvwEbjXp2KFWZbJMIP/G3CKkjhGKfkcbRTVj43kB7pS/QqSrptGroZhc5BaQ
uHa6RCe3wGjU2LGsvg38ez8q4jPVmtafc3YM+5J3WQE22qTRn9McgBzGwbEUZaBttfxvSXImo25m
WuroEQPrxE3pHbT4+ulQ7JgcbVBtqf1mhFpmB6V2bT4KMh+5Puz8anjobPrUTvYeBWXF4V8VIb0D
zxUl90cwjvG1bi4hVvsns4CTnSaBmYCF6TB3PMRQ1vVVKhT1hxrnTFHBJAZXp9jETGiHRlvy0GZm
iph6UESHKkGSH5iGdGXnhiC3+ZnmJ9dHzXg+Xl/MluM8M3J5MNPLTKNtjRzlzWxHyJGzhwAo9qqW
u027QzC1tqvZr2fGiowQ15uRhdQoOaRlEffvmBwCgMlfCdKNb2gW6uPohk28hoXT15aqsLxUS5Bc
jisAcOlrMLK+fKyPY/aOiwXx5so8u8bqMuZs69WozroaAk7bDsl84uJznb49L4c9+itjtbczw80q
SvvZT0liBE1Uj78W57kb9vqCt/nv61a1bsarE3kmSdKG5XXZ5DQZMoDTrl/akGkOWvzHqEAjQ5cv
++vStlXzd12SaoKid62sw95p3hGYMTNR+Jf1115bjXQRYAzDqQzNR4reuC/S737xqQFq81j+uL6M
TTEr8hecGWYWXOtSPXwYfO4tM+qwNEimvLlriBlybYmK0lak5zZFAb5ozYhgWkGuAGU84443BiRZ
qIvuTmH298RdhoM91FPi00kVnm1qCDkNsCyia/hVbbFservQ0VuW+PnSIxesTaFdq9Lom0LwjsZL
F9ObACW53L+5QnYGVTOS2Px7kdao+iki2U1/fCZAsgPMdTZu0ZoEvDbesfEx7RG4H5082123g+11
IPsA3KA1IyzZAakq0BFl8DTFtNfR/VO/PY+F0O/v91f5Z26gJYvdiBTXSvmJo9VGBW2++fMBzup6
KPj7KI5ffr7LvZ60HUXjRPnZ7g+IzN6xPWffl6LXGR05Za8hV14uUTaesI7/9n1p+825Y66f8yLx
pzigO9Vra/PoARcNTWignHuFCbk4I2A/asRIwfLTdEQ01+imdj/XoPW4vo5Na4Wi8Y4AxwT8yaUe
gs7KGGJn3IiGG1J0KqJNMnKmKb4uZms9aJ9cQaxxd70CS2TDPKUlnVDq9fy1cEVNd7c48dCZ4XVB
MgXNn2cL2N9R7gFeCuYopADZKhgzsxlOq81BVZTWz1qHyfdRKyjatNEY2PAiKvMxrvPDBCTgIRBg
E/UeynQ+NNw+ePmX6z9oy9BBA7Pm1VDohl+43OAsQ7Gz9lFDEdPxaz8pAjPV1yUzt2rejmOK26D/
YgnQbSp2c8s6zn+8ZOW20FiblaJIrHxfd7GoH63+6/X92bIMdP2siGEriKbcULL4gk4TR7gRlHbI
nr27gUZzq0oIrk5XvpxXOE4Hrxo0Lstev2z0ue89nKc0K8PB+dADkKM8Ts0TCwJMkKs6WDbVciZO
ugNat51FCWBXoBq+4O1p9E/XN23rCYVyNhoNQQjzmjw2yEEVS1I/A+e79WgNQKXJUyRRO2u6Zb0d
ByhzZunwdRhV9rYVsgGlE44JhxjpjdVgzm6FCdh5RWAUeLHraHadZtCMm/vZ9I6m2X9sp0DhnVTi
JO+0mHT2WQ1xQPAL2TTvS1eL0UoSOVQ8ogn9HV4KwA6YK7JWNjU5vC5HEJKOC8mRzy2+cqvEcEWJ
JggNsGgqTumtk4XeFCBVBRiDeAUXSrR2cvqxy5PSjUFUsxQHtMleNxKFCBkqVGeB7fYeUmqs/mo0
n7rsxxz8vC5iy87X6h2w2sEl84rhuS8d6gRAv00Evyu7L3nw6fr3t5aALjNkb1YYDBQNLs1tJjkF
oTApk5rjaWDPd7bxxEC8cl3K1irQuaEDKx3TGahNXEqBlSFB5Jdl4qTf6+zLLA7/7fuSF62ZVsBe
UQ622z06a8tWkcfecqHnv39d39mhrHzdSi0H3++Cj2i81/Pfuv7DLRXvQtUurbo6k4IJej/r87pM
pu5R3Du9YhFbHvp8EdJRB7phQdERhEX09xNoE3nxq2ow/DDcod7BNNVDXbVnkmVpgo2e2UPcDHzQ
MmzSJwcUyKqMhkqKdA8AFk8Yab9alt2FRfc1t/1waQ6eilxQpRsp6HG9IQdfGVbjs9/tUgNUSHFL
/8kmyxfomXpkZ1Lra2N9U5VA2w8AzHZXBqAuuNHSl4b8LPQ5Guunvv1hBTeDsbcM7XZUHSLFVspo
xIZHlr4q8ANSUK3NcZaDFRlIFzfvOKo+Qm4MS684zlJ1HWTYpjaZDVqPnYONHlfF57fuM4CV/u/z
UjBIu6DlJuYZEsz2Fs6+/NWWu9Q4EBU2+Wt7QCs60NXR5LzC/MjzZrkIKjou6HnBmzq0kdwcFYHh
a238AY03gG0MWi+8Ei+dAfzN7OV+XyWYlQ8n8gXYM61+O1e9Qs7rC8AA0NKKBYOCsf0qOgTFN0p0
Hpo1GPs6iqfWujUdhePZEgGgeKCOIcuBtKPkPW2MCUx6O5Kk1nqMzbFQhW6xpYxzAZLjnGxRA5kY
AhpQJaDJsVcWbjckIGEChBk00jpoOpG0UQCwsF9ySpM7wV7a6fn6mdjYIPSFoliCPle8EmUUOKRl
J5CRa9A1UBV7rQ7HDsDKtapI+voCAAsBMAZBVQL4t1fVGjfj7lI6eYXuthNNd5hUOlXkNCNQp92t
3b/5/X4pTfLMWu22TutDWnl0PhAVgsqGQgBpjoOHkuZK3SjdLrMZ0JlnhCWgcw/nJx+Q1td1ohIg
/XyM/2GIoYcAv4jR3jKrsL6l822vcCygNENzOSga8GCXvk8z2yIMVIsJwRBZazz5/gOt/ylLhWmp
xEj3Vir4MlsCYkYD1MLmk+V9mAFzDAAjxX5Jjvff9QB2D/3NtrFSQlz6q6Y3ay8nDPUepsXAQjqg
DeXI/CHKmoWHLHUOb9LPv/IQFwcAcVsn7yV5ZdZQI2CzmQBxaSLA2ysdxYokC5AlyEU62mreIIRu
Js74ce5fAK3xnhWAeNR3gD37CsAPCIaEO7VlJujXimeHfOiKQuF55VzNv2vAFq2AnyteuOQZ037u
+oF3RoJJDOcZdaxs5zWN/lLN7RQ3zC0/GXB3sc5s9jxqIrupmSmiwhzSmFJgtbc5aV9qrgcPGeZv
X65vwJbJYHID+Te0JKyQS5cm0y6jlU3FYiS5VR5IQP1YN4cHM23nsGD0rm+VRDBbKl3hMhxQFGK4
WTZSINSXAnS3MBrnlu/74Xh9QZufXwfEgLMJiDUZX8SnjmtqbQ6cbEBPdt73vDQVD6mtLcMrDb8f
l6nxqtWWekFvEy81E21OiuYfI/PR1d2Hi327Dry+fTXnssxL9QjqIQOrZ1hNHqWgeamoCsNQxmv6
Y57nIqRrtZ3qGRiZmpm0/oIZcdE0DxpHDbfzHHMXjELfO31dH5tCsLBzKd8ZKwPBe5aJTlVsKlp9
5XZPjTViHLvCSoR5a7a/slrVkrdlFRix+p8AKSStJmr1JYMAfYrTW1fs3/H7QVuMERngHsDwLtU0
ujajmdlYeNbx34M1YuCqiq+L2LQ6YOACvMtAElFuJVs4NeaAGWbiBelR+DHTUXepX0R70nRdoY5t
m0CCCLN8UAhm7C7X04yimPSKghTF7HfgOngGxsfeLYID2nSOxjA+Fna2s12aRaBAf76+UBmN5F+D
dDBnDLxaMNnITVJz35WABLSsxOJlG3Wtfdfn/sEEpEQxAfWgwyVjlIhgha99NWfHDfMgO4CXYwao
2Pi+rcCAlYMK1Ab2i5kPQ754HCewvG1Bo546uEmz74HVx2m6xKZRxjl7IPr367sghaN/NmFtc4Mx
IZv7ivBBa9DJww2Bi8m/M5ebrL/FwPl1EVtn4lzEGracpTrYaLDFmXB7681L/1CRt8Wer1awGvTZ
5xeg+HMrANJ6PnyxvC+KfhDVj5dCN4czY/Qs/HjzkzP3sZtZivOmEiDFNpY9VEL0EEDno6vzEBQS
Ct++FRbamFIN0D6PRge5cctoysDWKtcEH+Xg4nlJ7UMv0Bjg6JqGtpNe9fTYNClQugA5BVReuMAu
FYL6z9LWi2mCLsyJ8wUgh5kejeXu7VYFVDnE07BdGO+6r2dq10ozKzOPOAkzdiJWgnVvbRpq5sjM
g1UQCCSSWtqJVTnwq52Ed/d6fmqau649EuorPOCW9hHRIteLPAYKAJLxloxXXpFZTlJZkTuHTFdE
KVu6APr7SoUDApl/QWHOdmnkXVHyqXMSyj54/cuyhD05vEMR68j+CsQNFDRZ3YD1HTuA/yRAfTXv
UZq7/vnNFSBihAHDfl8Bs4uMUXNOqZP0+Xc+OZHr9rGxKNawqW1UbTE+A64G15ZOuc2XgrsZtN2A
pfmJZzGmpBXnfFMEqmW4UlFLBZPVpb12aZvjFZg6GNTYeZSHBPwwtPgxsm/X92s1zLPU4h93uGIg
/r8cyaI8lBhztnhOkhcvOdvl3W5hu7KYIjKzEDO84BJVZX83VXQmUto905ytpkGEnATTnoCGdtkD
Mvz6qrZ3b0W5QjX6Nfw63k5kngEjlPQ6WKoIBzNmbh2Xqfiq2ZXiIbV5JoP/yZKzlu7ACwEyKycp
deOYL2Q31c/XV7O1YXimYeYQJVo0nkk6Mg08BhtrwYYtWWg3TxpoVw2icC1/4hfZElB3WxOKwMMD
FZJkcbPHK4ycgwxuqt3HvvamcM5nHaUfbRlY6EzDj2xk9XFJ9QX9QW4GBOritnQeJstOrXCqbEAh
cep8QOu42YHyOwW8ULUAOQbMAgVeytR67DrH2s0NsIMYEd2uHC0AAgHAzU7wonR/CN3Lb8A2gEtA
iJLsxey6X5heFVFGAxE5tmh2o8XNJ1BhjGFmsnYKvSb9ECD2YgMDYs1B61dwqOFXLlhxMheCBo42
+5TXRr1zxrmOGgY0Pr8S1R3exGU4Lc0E/KVlDAO8nY56WlSKiGnLFP9ko2wPLYOocV1uq8aQ5HCy
2U6ClNlPVuWQ/Tilxbcly7JnjnqBwnFsmSP4twPkbA0PeN5SEv0PKAoVrYN62rPzYE1fr9ui6vNS
CG45vT76Mz5vGKFxh0mVd3weBoiLen2w+JIR2osIGsdunAQk1XZ7LFQkEJs/H802uBzWyTE5iDfd
moG8CJ5b3AKyJWyzX+/5/X+/v8o/u0A7U9S61uP7TuhVD4FqbHvTE5z9fMmYer0HopWNz4+ffRE6
+qGaFVfblgRv7QkDCwwQu+WiL05lly5LCmJV/4YZB4uVh4ExhZAtLZwLkbRcpMLJHAtC3PqOR+Ws
CMI317A2SKC1xUKDnvR50BOlue8yJ7H8R7O578xIqDChNleAKMwxQZkCpywdA71jdTdPvoPsxA2c
WfOeFSBTBDxB5L7Q8nFpRqmB56RwmZvodSzIC2k+ANviHZaKcBhZDVRCX/UAmjpIjxfmQQf2nvGP
qat4xm36vbPvm5dL8JppBrYddJyLe/yrZcfa3AcqWO8tPcBR/G8VUoYjtxfb6tdVUDeqnwZP4Y62
LAnPEox1BSvZuSctYtb1GTzbWARaYpFR6OuXnL9HBAa91wKbixqMdKRpMQQTN3E/iCVzwsoEDiEp
RKxb+XsO3QqZgn+AKiP3wnkedYRhl+CkL8Zxb/d+u5um9o3TrH/iScxL+iBewnAh+kYu1Y6ULsXM
UeAkWoamcs3OH+YxP+jZcA9K6Pi6CW+ZGE6ghVqJhVKrnA6yZmEXFoqkiTb6bQTGGHoLcKT2sFQj
aj4mUHBP1wVuWRt8ogvEH2BYIQt1uTirGry+YdjCor/1g1twr13//pa5AcLCXGmSQTAgfx84h9Nc
r+49RSat7bSd5bo3hfXGydl/dXQmZl3m2SVVGY3Vgx/GwSReNNjxqAJ9UC1DMunFbMusNvF9Bw+8
8YNjngb7eH2nVhd+GayuNfa1VQyAfwgVJP9raHMPcg9q4yGceTfBALL0XAx7sdA0rHp/viPzNMQt
m5zddcGv1wbBmGIxMMiCVgJfMoHKARFWSZFHWDAc6+Q7zy12yLJfF/Lazi6FSApCSyTm3isIKdoD
pRFQIP/b9yUF+YRRK12/r/8e249l9/H652V0CRjY+vsBU4bbS8cuSdeX4wKL1bALBIlkPDS6HU1c
A4yNh/wRGozohMnP2dZDiy1BZIz1d21RMeG+dg2QDEfjozEOwwyvkli6pa2TgXait+zGQj4rFITu
25p+TPkbu93/rBa1c1gEfA0g0aXn2URKqyqW3kr67ob4R9UVt2VxaL9DmAFHh4hY2kwjt3Ob5o2d
zBZwS2s/LjJjHyyqUsT6GflEnYkJpHcDoXrZ+QvDfa1VvXfgTkoTazLqT3Nem0kGXEXQPVc9uVka
Jn579Zy/XLeaLaNHC4iP2jcsBnS1l16po1reFhRUpSmKffUMPFIR/zcJ0m0+AscTZUXPSvJnQY6V
efPfPi+5hrT//wUUSwG03qiqVRgBqyW90tHZFkl+oQF4rKcvroXCdg68473R4TF9tL95oyoJvKkM
hCQ+Wudh13Lli4mmzOsR/tUJvvs34Cm4vlUbxWe0MCF7hjQzsMBfV6YoEmg8QBYwNZ+H/hNHbsMG
VCxAFjIaUSEi4S+YsfPCAmmo0dgPQA7/ULy9jI9fgQFlQMUhhsdNcmlyVDiCY1IBzvxHbSO0e7q+
yq1NXJuCTPBP4S0uH6kMKOsgS6idZNbRi/LZeDt9MNLlCIDQKQK2B3TPXv78cuq8osMbIplQnA+7
RmHPG3csJkF1pBL89ansS7vTcMeqPG9JE4LMTmV9X47aP8BDAubwEvJR1SSy4ebQ5QRUInjrlStF
WozW1k5lljxIMp7GDDSXPttP6Run3FZfvRJjYMfwrMILV5KiC2Zr/uL4iRWOHBUz4Gq/WecI5f+8
CpFMw+VzqROeGxYbGo2eKP/0Q/Dn61/f2KSVqx53KoACPU/uDOpBhm6VtahPVooEW1xb/wSjQsSG
0V6IkK6bhtIicyaIcPYaboBWMZm94cIAa7WSncNykaSSFOD3mAFG6w89+WS8yQHCbRtobTshox/p
qqFTlSzJ31czSUmjj/S0sr6ZWE6kffPyh956R7xzsSjJ8wPWwtaMvqenAQRMgD7vCAE33AMR2a3r
02NWgQl7FGwlYA6BAa+CqdlQ2dp5iBo/Hibuazc2C6HRrKMnz3kEuPigUNlWOHfxfSmfMtsFbVjf
0pPOQU/0Yvr3Dn9wmiMNqrDPb5i9c8iDnb2t5X09qq4D8Ig/RUFEBZIhIkcFzmqH0lOOuZqdxxWf
3zSOdbDBxOgEnt/rUTt7BAUGsQazqOmp0B5Gd0Eby3MxkKPusnjOFLmQLQW5yMWCBR0lL2DTXcpq
G4OzrMrgFOZIH/TQyYfozY4BtyjyIAg/UX2UB7naFkQfZPZxkEBpZvQPLRIWmv317UKQHV3LAwA9
AejS5TIqvR2nkVjVKceYuBGVBNyQCve54eAwlPpXxLqTZ1phxGlFQZ3qNIAdsZhe/O6uRQni+jo2
HgcXQiTVl1yvKadYRwoGAT8EdbzT7RFcX5eyZWDnS1l/xdlSuE/nMhV2dQIYBagCf3ZzgJLFD1Ce
uL5CMZsn9FzW+lvOZOki4EwjkOUv/JhZ+k4DlzvPvFCM7Fc+iH3vD9/MjMdZIBKtygzFjqrWKnkI
j9EcwPhudRIY9yyRtW/7e9YeMn4EX+v1bd1Uno2IDajOcHjyc6givMrNCcqbMdXhWx9aL5qMPShH
rovZOrLeXzFy7EaRJDGQVYAh5it+EA97U1E33DT1FaFSB1jh2ul2qTNiajnNuYk9m//prRJ9Q99N
XeHkNjfrTMb692d2AZK5vuxTozrVeUy8qEBJbYgM1QWxsRJPB0Aenm0otmIxkpSON9lIq+o0okEO
/HFRvTwH+ZtT4gihz4RIngFXha73c1mht+JDSX7O5m0zKnoHNvrLLmVIKqlR2EK3K8IR1h9c7x6T
/YizVmpUEnnBne997Yp33K1YFnrKdGzfa1jZtrLqtuQMdoZKqDN8aVKw0txhZiEc3O+u9xVctZqO
qbLddfNeL0/pJXkhVgqNikorvDSD2A79PODuDlAKnSNThNOw6819aqvC+w1LxFMCkev6fMUNItlI
6QSAAJ7t8mRWMXxEOh2KJXINxbI2niwXUiQj6X1GulS45QnZc1PcePZNN31rAxaTQgu75fv1Tdy0
e6SCMeyDZO2rjtvRc1veFFp5qs3fhv5iNB+mRhE5qERIeqqnxqicBiKadj+QHwXd6fOP66vYNIWz
VUiaQUN3RysPBwtPjqNR/2MXnwKNhWz86dSfq+JWiXGjWpOkpFlgIJ81RXXSG2/H2Leuu6l11YzG
phAMFqHVei2syK2vmjGOIvVneFfnrgboNNKNtafwrioZ0kJo1XVlPyzwrlVUs7AHXvsbiVTWIHjt
fsfrAswcr0ewajB++2jCKE9z/lTVwIf4OL29V2YVgZFxZEkR2cnT+f0kTG7QoTwB8W8gNyY/NuNj
Oqu6ftbNkD0O2tKRDEGaFJQD62aeXUVamY3occF4kTNGfAQB99N1M95Sxvn3pauuDJjjlMP6/fnz
mH/Vml++amxJJUKKsohJJ2cqRInXalwMH0CjZFrH/7YKKZByu76vGjqVp6XbZQE408qbXjkgtbEO
FAABlu4hQ/66RcRyhUFRgeKn2u/2htBj5t9xU1XE2JKC6jvAnoHNiqZC6aUPDi83S52On4z+lhtH
m9+IXHEANy4VxIF/qjHA5AdryaVNjVrKDIN1LUx3BLHUseyrXUt+5m8cf11P4ZohxEgR+qOwEknx
uTbxuanR024HbdiLIPTJENcZMB+0L2/Wv4+JcRRPAP+zQtlfrgjtNbRIB7098bqMWfGNoI+8B0XK
dSlbgc6FGGnj+Fybft5PWJDBYsDXoU2yCWdtjDJrV4rhSHM/nLgVCv75uuQtozhfn+QyRatNi9CW
9lQtZTS5H6hthrUqEb8pZIVqxvDq+rpfb7wzV+NxJ3ObBepqx/l2BNnAMr+k7dvjUbyz0aKBnAtA
LmUhdt8zHxAP7an5pOvIupxSdGle36wNlwkEIuR117QBwgvJ7NC1YQWzB/OeSnETOCtNHlfEFyoR
kr9BtGQNJIAIg5o/7Gz+aaL37voqNrSBXoAAHVe4wjCZJNnaQsyBggKCn0RRHYE69QFQx3vbV6WL
/qSjpQvmQo5kWhV47KsFL6pTVZXiFtOIP9vR84CRQq370iPGDVpFzAiVb28nnCkNy9TzH3rb+2WN
unPime4cWT6NLwvowcJCA+Czz+1iN7neL0BZDaEVCCdudTbe2Qutblo7+1UMSOottvbscm5HnVXU
UTf7n8g4wqd69sdFL6yDxjG0zwItfV4a3Xzws7z6ZIN9I3K7wAwnR2BiQ5gksgZeRx5P09BodYIE
yxBEoJ1pjrlbt3ue11PUZb59FJQv+3p0QKYwg6jRdJkVo8jQhACLy5+bouxuFmrqUT4Z9qcAtII7
jXLvGb0LHR41+vB55PUQpa477LK8DfC3gN/MNcbvfIOlUecb2edAz9zYtgXAGWzMDWECb/1jVtjV
riG7vLn1/b68xYCIE7Z5MDy2jV3flhUfwCRTsXD2CiS5ZlM7kBLccp5oCeCLTBJmFQ9iY7D93XUb
27gIcAKB0b2eFiTGpbvG4P0MztW8OXnN17F87JY55Hg1qUJllRjJO8+MuKykWbPezuDtzsuHHBOR
zf76Yv7k0WRLxjMGsRK6G3BgpHMv8izTYCXNCfjm3jG1yyniaGaJal4Dq9+aNZBTEi02Ofh6zJGT
0DdnCkxF17jt3bY/FT0lR6sfyD3lIKgcwFJ5N7t9uVtGbj311CoikInaERE6eiSsoY3NrK+ixu/m
l7l3gkNNpiU0OYcmOfvGegKu4xo0z3MwgNvOp3HGfbBGBQ6PdWcB0ZlANRhVIj+sqFlHBp5MoWFO
JzvtRVjXrR92dMwVT+d1F17tEsIYOBWgZAEh7dLLN4PwfYyD1Sc6/VMMN7bBdwO/t/Nmj0HL6LpK
Noa/IOJMmKQSP6BASmit+mSLfzrtLnXANKB9qufV4F+a4FF3mn1n/x51D1jqX4pMYRJbhncuXnLT
s9nYlZ5C/IS+UuuIV1n1f6R913LkuBLlFzGC3rySLKeSYUlqo3lhtKUnQBK0X7+Hmt3pKhS2EK07
N2bugyIqCZdIZJ48pwiXUXIZCK2gXx4kPCj3XeGpxpLETTm69Wkp0ecbaHRX9L7lSM6q6D4Apx7A
7Eh7IDzkptKO0bI0QWn31FUbHUiGZks6yd0suNUAIPhjgpuuZSGu2bt2fUqdT8Xw5sloLEUTBeIl
pNtB/43eDC7ASAvaodDXkZOVPZnTzgiWadfmEgpw0f5G4RWAPYB98IrlfJqXlglEYjAI6j4NyzHW
E7iaz2XyOg2VZHuv88EfJTwAgdrBtXjN/mD2ulGbhQf3ueaoSRJO6msy3nXzD8L2lfXP7cP0/uVX
5kArhVoIErhX/IrNkhULOA7qUxmzwbdHqqOeUFvtHt9G/XJCf0Fq9QVEZCFNMBluF2quO+7AeGb7
Mbgw9p7iaj4kMbOtO1bpnW305baw3DIAzLUMlJQifTU6Nn1uGjZ/0qBztMlzz3nsrKZ+Vrvm1cqb
YmN27Ls1l/1rVWbOa23beYiweDpMGlKlmdXVYFkmLgn7xBt/tFnOAhDxxLvZjjt/YgN0pelSv1b6
2MneyqKlPw+Z1iN0FsDaSZ0voJVuTuBhqvHteumrWhPQ8ZB6ssScaO1N0Lu895KuKdxLW4nTaWqT
x/SkAydtz6dG+WIAv1IaxiH37rW/1E1cn1Kou6NP2HAMNLLxdxto0ZYMWAZyyls8orXsMWeNxMGI
Tj/k3oGUQkkEr09u9kBrb9sJxKhPY7MM6DDKlS2rczeU7GLBmUFeBtALkGridHJuLG8hPogeF3Jq
D3lyj6n6336ec2FzlyZ0yhT8vPXt3qu/3/51kQNDxRguGCDTNR9zuehppim92nf0lHTMQmWAVH7D
oAJGYuUe5RXJVIm2M3hxcOIhyQBXxi2Iieg5U8YU1kiOZPO+aKHHreLBlAcKkxXDxcYgWQ7IioNG
GO65YULisCvbkp6gMl6WnyzkNSAH5itN63eujGpS9JDGy+aPtXUvnp1UxZ0SV7FhbWyyII0XP1FC
5r65zSmxX5rqLVE7f6i+3V490ZFFp+yaWlkXj6fv1dKx69kId23WUZ8Ph7YHvaoJua5pn027ypZF
P+v68P76LLrmr7s51p1Fm2Pc2HCkynw/xQCgyYgEJEZ4xBlLWtYrE4yknXo0k/wwKtpDEy+yPrd3
bhZ+NA7a+AG0BrztSr+NFkmVaKVTn2INMr1ulaU7OmdDQDJ7VvwpnsdHrSDupunVt3woqsCM7ZOa
5mU4GoPra3WtHECbkoZV7b4gaVuERp/koVIt7Dgk/SenJLLyKi/Y8+41z795Pc9n20zTq87SKsRM
KE/t6l754rH0GDfaFw93YAuha9Bq+5457cEzAv5zEvSLLKki8qrnn8D5u9mLiy7LMW3q8qYod0ac
SIIQmQHO41kDnrPpOsb+s+X4TSH5edH+Og+hOb+AXp6KUby7T6SpQ2t5oNVzDzu3T6ZwDGfPBM4d
tLkLhKwKI3kVzHaQyhCsskGsfz/bBxmhpCvXQZhukC/hXAV6Lpkn7moAhbN2wZ7FxQO1MgFiSkFu
VdOvoMIZK7iVu9x6uT1RIiu4m9FBDQgoujf4geQTazySNxFIM+l+MA5tsi/o/rYRbjXeh4I+l38B
4Oi85LYsbbVYQ1snjawfjffZ1D/d/nluMa5+ntuw/ZipZNJsGtES3qMLqj5040WyHEIj2JwIZwB3
gNe/XHHHUZaMmjmNnP4OqRYftB/oBZcEG0IjDnKZ6irXA/rdSyPEyTIlJTqJnHae9kVWDm9mlvef
zBHpmtuTJloTV3fRgGkCxQi056WpijaWlWcFjUhxjHRF8vATDeT817mBVDZiP6vArzPrrs2obyAz
2/7lM/l93RHHAM2FNmnjKvNbaGVKKoolIQkoGOzDPEcke+4XyaIIZmrt+3dX6j+oGrvcylvKHKNn
qyORqZ5oHRV/vxAXP8+FgArCJ6Ur8fMxzgeN/rL+uk4SoLYgtkfuGgxsPFe13UI+vUGjfzQo1UPV
JOC119o29BaNHW7vKMGaA6G+xkK4zWGKc+yWCryYkS8kwp7zi8zwtSELRkUWV65+7yxs+HdAZ2bW
5TpzvTEoUIfYgJmCfm7aCdrZnq9bT7F6VJTIUFgwzj8+MDB066lrhIkkF5dtbLq6ZsmCGK9Ys3tG
OJMnpZL4YeEmO7PBTR4b4MOq1UbW/kyMBbHrr9uDEDj6lYodLG4rMuiayU6x66IclyTS6f2yPCt1
v8t6slfH7u+u3vf1OTfEHX2nyl0FkMUkQl6zYFBhkrGuCvYZyJZQlINwLrR/eej44JQUcINZeXL1
N6T5mHEw3b97lq1jQL4X7DQrOB1yhOsnnO2x2R4m8CIPypPuvZj57Ov2d+Y0/jJubi+KYNUv7HBz
he4sr+o72DHt0SflW0MlBrhH2L8DQWYWhKWAhKGR/HIgdYI+8rFPEoh8NTgpYKJLdL/rtAACk77R
ynqXBJsMxd8/5riYBdI1cVHTWHkqii+t9eDFmy7d1abEY/KPvX9Hhbri2v+3UgVyLpORzlQbPU0i
pgEu1Qa2Wm01swen7KfJ+epAPrmoX2OQcX1gtYCXN3DpgLWAL6AVUJyDtgBNItBmVG/TX3JN/t9R
/fl5zrEtKM95jVckoH7tgkxPfVpKPPS62pzrRKL0jwVuW3eWWnhe2yZRt7HL0CY7Jfuipn5PN3Fw
e6rWX7qyZKFyrgNm4uDfy32HKKbIy8xUntBB+awpXnpwp7E7aGiZkIxJeITOLHHO2XCIMpUtLLnt
1iiCkkoiGeHvw9GAA1T3wALAxa4G2kx7gE2SqP2hTruMSvayaKLW/LuHTWUjIcf9/IzG79QsoGo8
JcMbY2RTGN4RO//vYxhcyX/McH6AVaPJlmEVT1b0tyEzX+b+I6cD6ngqbkkErwC/Xy557Fhd29cs
ixJynNu9jA9D5Ml0D8E3gmMk4vncR9cbOSGGlUa1AyJZRQ/b3AtzckfS7KDJGkmEq/LHGJ8DMVVC
vZo4kEhdik2aWF9KKM0No/nr9ikR7S1ATNaGUgTLAAJdTlkydhpBZxekd9ndr1z9wMkApyUedtAX
XsFrl7/uJtTotAlSuLMddsOD8vcS5qBtOft97vLSJ1bj3QU9X5M9e067y1wbZFWyNJFoKc6tcAek
TixU/1WMwiKvWyX9YstSBaKNhT5/FECA7QBFJ3dnZSpQAh3B0XB0uhva6oiG22emTsi6K5tUyWU0
e6JFR/0ERHsg94PsCbcsY+1Rw4lxThCu+Y89npK3N5VoPGuxCp0hKhRZ+YOiVmoJ0uIOHoXd2cOD
qwGQ5cdemP28bUe0MCsxMuL99VLh4YoW8JaoVzWw41a5b/fpXlfog2vJ8kXC+UKlQgPuayWTW/9+
FospKLi3U4P5ovcF0n4ZuBBvD0RsABx1KPPDdTncDiPeUM1Um7LIatONa2+G3JTchqKwCPkP5IlX
cfErlToUWnJndif4rlZBM03s9+apH9NwSWVFJLElxHoOsjnXZDJJp7mdy2bEe1pgOJU/+EUO8ID9
oQH9McNduotZFonrwEwCsPoAeH4DXWHSdTt3+nx7cdbTxwcSaEFHkwlE2a8l4ChYJMEKxtYA1mfG
3hq3pnZfQua1x4s/kILJ+Aae9yDs3B7nkklMZlY2sDcjUK6hkma0W/upqP1sW/p9F2bQmCQfyDBA
Z+PPIDkXpNpNmqfQAY2MMqBlCND37UkUHVVAgHQdDcQCahuNKqiekxGT6D1kwxzWzTF1ZSA5mRHu
OhjU2c5LBiNL8zo4bUDigzPLHv+is4o04kqJpQJwyjtrgP+nsXDwuCT2GxueZxmdiXAQa7kSVI9r
ZZTb2L1n6MRTWBr1RvbUT/NhFfkcKP11e0H4OsL7NltRgyi/4soBxxrn1AD1dhmFKlVPlc5PWHyH
buutoRTRAjzZPK9SMmZABsA+NBr08RjaZb65/RGiuTz/Bs7v2Xpm5cRq0kjxtq56nIe/rJ5fDZI7
S6lpZYDqYJDDeMwJGB/rrbPYYaEigJPxMAsHA9iEhnOkIkTkHhz9RB06xg7CdLZfioMjiaVE+2Jl
5sTFDZb+Kz3F9bZ1kdtKolqrToA/PChAVXVQ6v7AkuAloCLBgbQdz1HYLAjLNSheRmyau22RK85v
vbWgnHDbjMipujbaSNa873U+3tKSae2STaPWRMhGtF1ND16Z+gnIHVJrDC3yIi/JiK6mc6PcblCY
XjGdaWnkOn3I0AdXp29NGgepKtsLosVaexIxQLiJq87ErorrhKRQlRtd8gAWlc73SBZkXv/j9jSK
9tyZHb410VOdBZjMPsUtaIbJpIUplTzbhNcRSO/RbgfALhaLO6MW+JVivVtSMFfYR7rQl7hyn1B3
9NUhiUanfY27BkKl4CEt+lDJZQgO4Uwi843gBYcKrKeXbgptInOsFvG6ZukjhG+iIU52sWt85IIC
/wj6PMFygk3JucPMRfmeqmMaGXRGmev3xH45VJaYFAwGuxot06C1gV4Tf3eQPBlMvQWPuaYrT6Ol
HJZu3CnFJHEVgn0OMza6wBHuAY7CLVni9n1l6JizlTWF0CnIcMgS5ZT0P29vP+F4AOVe2d1W4BC3
OANA0hkBwjTS2/yQDMaOaVagdzL+QMEuR9ANghPQSIHowuLMVJpJWWekUAx390m6k+lCCUfx5+dt
rrqip1PO9BnPL6oUvjMz33V+DLqscC+zwl0PNcRVk6zIoLxrdYhMPB9YESChZTGQKDNpw3mjiw8s
s3itcHaUdujphKxrlPeABJTbZgBji0nD3Fr8QWkhTPCi6Y1vZqfbe2HdVFyYfGGXi1sS4o2WxbBI
6PPxU5KGvf0pJocaxOFTKrs+RDsC/WnYcYASXbd1zMO0KM0wKk8o9/xTVsDaZ+Onvx8PONwBg8R/
UQjnDlHP7FG3zUV50tjXtm83KtQWve8QNQ6VUgLvFJxXsJRjxZCFAbMkf14bpyXog2ySKE8Q5btH
S4s3CwgomuUDJeTVidrojkDvEuBql97UTEzk4glSGdVKubxo+x5Kbl4jY8bjMdJr3HVhh7tpa5v1
lCQGJE9n5SFWrKBpq+2kdruseV5otTOAzTTjPhjSZYuy075zwYhCZL1Nq1/gtuTFV3B+g+VNXPc9
viJhhm8yElQFKubTsVi+ePHog6QbjcDPt7fNOrIbNnnO5bzTKuj9IbBx7A6ZgsfEBcK+Zw99q+8s
MkY2e7ltUHAU1sYjkOzBOYJLhxvkWOeA61E3xZ1ihEAjh53sASyxwA8JpObGYDAPwUz2AAVd32a/
bg9BOGeANazEnSsbh3G5K+fCoCOyPEmk1U9lE87pJtFCr3htxt34AZVBFAP+2FoHe5bLoaOn5rmh
JuDV3CTG0SlfzEkSMgk8IUwgnYo+JwQTfG0IvS5pkXoWnqHjUcu3ZfGg0r355MiKUMJ1ObPDTZvS
gyw9XsuchncCByCtvt9eFtk4uKkqM4OADxe/32YbR9+3dtDVwfDLUw4fsLM6jFXXEEUt7sZqlFbp
CZB4UW07yd6d4890Mj9lg8n8cWbmIVcS2SNeNDQ8cYA/Xel8r4pDaBVxqTMhgPWsOnlMaFvdtYli
bcpsaoJ8WLytNxbk9+1xCiIAtKiARk9D9QA0v9xJbTtTR68AXnCe8tTS9jtKi9/jRHKXCI0A7opU
PmJ2/Odyf3doRWDmhLyY2n1nngLSvE9T8oHrF5BtFCCBeMGL9ApnUU/M7oBLjmKwWE0W9WXvJ+H6
4EELvUsQJV0FMbXrdArULdOI+A4IXL2j2aDS8kXS5CI6QNhxkAYEaBt5FW5BHAJNcJLXeFsA3tne
pc0seeWKHNuZAYOLLOFszHFRK6Qf7J/oNQSfoVGEXu3rZTBZ4e3dJRwMnCcK7RgR5CIvF74vys7r
WYIXtXKnbFxXckhF+woECvDvqH9dF78YqUhfN67y1NgGGFQpxNhTh973YywDUouioTNLfOWLLKnB
EqDPoRCRBUt3GioWmMrsgyHy72fMRsYdncF4Xl7dnGxWYxvicUnkJgQdjcrsHtMFgMrbVkR74MwK
f3uCwMrrqzVv47jlm24Mj6S39rppvSSFu0fsGXjFz9sWRUtlo5i0JqFcPJm4ewHt+0072yYssl2V
AvOOVldTMneiRXKQ4YeeHKoikNe53G32Amko1wL+Qe8XX1MfKw3xlAMWJhmNi8gQqgirWpOtg+iQ
G8yglGM+ERhCn91dTJLYT01lNzE1hJjGBwpjuLbXVAc2BVq5uVElnj0kZeVBIVjTgwQD0oLbSyM4
pBcG1tGeRR8etLOtQXWzaLTUIJlCMnzADcACiDVME4SdqI5eWlhoEiskMbOozWtfUWtfsrkE6wGY
ANB8IAHV0LPFjSCxFsbcYRVRTmdQ/uGIEt0JnGT41Xbfbk+W6CkLUOX6MsJ2RgWZ88/Vkhd9bKOO
GA/xvduSX1bTB6llbox+3CfJEg1tfueBc5CRQfZcX3+bi+PPbfNeyAZjpJkQ2F5QbjGm+wo4v1E9
MmXc1NZb06JJe5R4CtHmwJ23crwAW4bw5HLpSuRAvKRE6rXJEgjl7CZVBugWeAYXAJKVxheLeMWE
09WjN3lxm0WzYwWzBwWh0QpLT1YvFZpBNwoQKw6iHT6HjM67KVOLBWkuw77Tei1w3Xifmn/ZF7U+
MpFGQ0SFwizal/jTutJFEsXWsshw9l0Skv7vb2/cdcBAvyeerp4lVTPQDrsSBRF0fljNLh72ehUM
tusTQv3KciTOQRD0QOMXDbfwc8gQ8vhuo2o6tauNAs9VEsxgzrN7EtT63kmTfStrvRUerpWd1kLW
E2J4fHMUYXHb5F5TQFsx8RVKg7T0/HTQ4JYgmJARH738zPtVWbLn0XtHGX+0UBpekx0e1pA/1khK
Ommn10UErJlzBOip9FOwVh5ZOU0+0j1VaBvURTmKkACsrVBxotCiHsBEe+fakP/V7Po+ztoc/Cup
kz/TWe9Cr7e9DVo0f6XOTKFya04bivhVEjCKimaIEwH9xdbGa5u/9kBKN8w1GgojENfe91p2AKcs
AAdLQFsH2bUy0BtlZ3YgVcyb+qW160D3Ykmzu+h0rXhzoKrBknzVpYm+1N5yO1rg6i1eiTkDUGXi
riIyNJUoiQNpwf8M8ZGLXYDdnRXYIY3tTT5Rs0PXZPcOnrPkqaPDHmnZe2jzhhOxQy0hW8UqD50u
63cXeUVAuZCZRyobB557Hdp1A6kxxaqieWS7MVX26QeqkJB5/mNBv/S7zkT7pXdgoSQ+Gs56c3f7
HhMtGMIwxLQu/sHT7PL3jbYxSpz5Kuqr5a4tX9102IH987YR4TRhb656Uxr4VdaPOIssqKYXleGC
qN8adL9RwlIGthHEsSA++mOAu/izxjRSWsAAoDDbvuw34wwtaRzZ3yge3Y2tWvkzePvD28MSnTik
OMD/i4TlKr3MxTMTgNCNm3tlFLckMHIvSGzTz4pfVlb7zLnLYwhAP9l2uXWanxnwRrfNi5bu3Dq3
+fpyqC0rdsooo/cxCFIqI9mCh/a2EeFBAwuXrSLSweuNv/gBvnS1Mk9Ase11IFmp905CD3HaoJUT
ygSjBzDxWn433btFH77Us350p/yB9DLFMlFsh1ZpvIRw7pFa50bLDCXtq6LGRm1AqAqCK7pREkY3
me30fpoYMnYTwexC3w2oQ9Cjr9UdLrZXakhedx6pUWuuAwAIg8x51mQk5oJB4Y5B2gXUSfh/lTvd
Hgh+J4gHFlGXA/UEsKDPwDVp9QiPbeXvi+cXtrgBLcVkVXHsFpFWbU3Pl+q6C84ghqGBSx6JXnAo
cQGx0dsQ65nSMsqN50yzNjG9Z+Xvpnzoq39WslXJvhTEwOfm+IAk7lsgtWOYc/WTphzb5qAxF3HC
g6X2fjGB1Hzrmd9A4Q6JxheWPM/TFNba92n8NsS/a3ureL9vf5HAyV18ELdBjd5YBqgOl9E0bJeT
Nhxu/7xket990ZkPNY3FLVulKCNPVQJvOTH3WW1OA3lO4s+lKqG+4HUv1vD1YjDcZnFqrRtsL4O1
jAbz8rVNjnT+R1V+gYKvi8HZHR9L0vkx0wOSP5XsgBqRX5un22MWncGzLaWtU3425kZDDIWrvYyU
7qUH40biL97n2yaEJxD+xETJCQE7r1Qwg31jWTqsWmH1G2tRtpZa7gtPfwKEcH/blHg0f0xxB6T3
ChQZQD8cqeWxyrtgzg6Mvd22IQjTkfEAVhNFtFWkZv2GsxkDjo1mtQVvTcF+lNr/eKMbzvclGLkk
hkS7HY8B/KCJrr8rZoZicnChubj6ynwLAd6/JMp633/nP885xhS0da1uYBxNvs/KUHUfOhPIh78P
fqCngscmYM2rTBoX/GBTeMxgOiLmNFTLw9jum15yf4oW/dzEeqzPFqT0uoUSAhMkM8MyeSDrgwKc
XLeXXbgaaF8AjB1tWWCaurSiNvZsjhpCf8/PnPvkL6WD/10NnA7cvHiRIf90+fOKm/fohZ0RbNPe
nx4LS/b9wlnCmwEATDxlr7owzb7LrUYd8WxIqrCArno53Ju2xJuIjrqB8GHNECMJbXI+rTFHQsex
KqO07tXt2MbWxsuMal9Uxbxj9lC/3F4UoT0EvABi4mVg8JmGwfRqs6VlFWUYzIzMzG5Iv6JQdduK
JroYADT4z8z6GWc7bG3TAP1iVUX56NyPle27SfVYFummNp1jarq+mhZhjfRQ6ix3BtUPQ+1tBnP4
ZrH8jenlY5/RDTXsB7txXyXftt553GsanTvo1kYjmqNdZXvXFJmuznEZIev7w24YRJRRufN7cNLc
JYU6+EMBceNGnbNdreX3dtfsaDIPH1n4s6/grhFNjRed5viKck585/OiEn8BrLQzP31ouHh6r42w
WHXunKS4GanRWGVkzPmDotQ7tYQ0bYr7Mq/prhzTR3syn1tnfiqq+pM9y2IE4Y5z/7PPI+7KdG50
J4F9b3oxpufE8NU20D+QQVsLa7hgnPUs8V4zIxXoqsyixigb8FQ+1uhnVrPt7bkUeYRzI5zf7Myk
KdUyq6PB+l6zvTL8WGTCBqK7Epp7HurEgLVc1VmbbvacJLGrSEe5XW3uZ8ULVHvaK+Vd08p0GkRQ
RUBJ/1jjXDQbuslsaqeKnPQflHbQLpUGSJL7kBYPvTwNkrb1aXVnmg9orpX4CJGLOLfNeT7amFSt
dNjOe8uvzJfBS4PCynwbh6/LP6E2J7mPRAm8i9FyR87B81tNW7eKYq3YTh3xqfqiTfWm70/u2iLe
bDRz8cc+/cC2AQc52KLBDoj2ZO5GH1qSOOXCkC5BU4dr3M3lN63/QEsU2p7RCQNlTSCqPW5wI3U6
OifwuM3SviyWd6xqMFqqNqpZk3PIYhmWQrh3zg2uh+XMxXelppDRWN++7TZr/GIJFiPsXLCWgmnd
H/RTae+ZDA+6joL33WsacS13oh+eL0Ab9tKP4BEA2FoJih3RN7cPuPDnV8pAXE+afqXr7JVm0uk2
2orIUvsVfWi6/W0DIg+yIjPfs0JI9nOrVNrMY0sGTONgPQ/koHTPsUwVQzSGdy8IXQwNuQnu6mWE
TblrFICY1sdq+OJkkuBRdG4RqKx3CZpfbb5NOJ4ynaQDhlAn6Z64Vkh7BdzeBrodlshoh021VM+3
Z+29hYNf9nObnJ/Ky8FB1xpgs3XCtmVdBGDh2SVEDfuu2BSa7SfIcvdVGaLDaUuadBvbWYhsLHKw
eGa4ddSUS5Dhby4j9xVL70FBcqgtGmI0QcrSn7lZQOWsP7KYBmD8Dd2eHUjnHY3YOTSmvVGrJbw9
JuFOAJerZeNRi74YbpmA0l6SyVtbCodDTzYO2VUfaLP2UAeEwDNqZHAM3M2P7HpuQa4W3b19iOSK
YktOi9AFnBngS6c6Oq+SARDdCFR/vmUcZhBpWazc2sqpdDZdd2LKj7ZkvurKZk+4Cf8MjU+8GaDB
RhMBEMi9smFL47fOazJFtItiwqAdKlkr4ZE6s8ZtvyoebT3RgUKv2PDCQEw1FIXstSHMbpxPJncf
2hOAiV6FYmZsF/u6s/2htfzCbv0sMw92ZR6aevkK+MMnU2+2eeWeSgudRpYBJmtta4z259v7Uzbm
9e9n7n0oUC9y19qqk91bjKGutEjuY+EJOJvV9e9nFsgUg/F3waHWutGf4/3Cng0ZuFu2T7hTZjMl
050eK5eTIYjN15lS8Ggf5mLYFuSH5kliGtmkcTc9FE0s6sQ4EEp/NKoENS1JDkxUCsSZxoMXfDDv
Ve/LSUvyOk9Bb4ozraNTtP0a5694x6vx46Sd6uHRtZ6VpQMB3KeBfqnKxi8JqFrjwDSYX0JOuvyq
ke9s2tYyRcB3xugrF332YZyzyWanSpoZH1bYjwPJQxeQ+aSN1PmgQ4uYGgC1k6jXvy/0p1p/G5pt
Gv/OIV4zvN3et/+fc/T/Zgh6n5czhM7/WstKeL1y0YJGsR8nwPv8TKu3FuKShal+B66exGxD6KDv
FtYFJj53LvK9Fqt34HX6efuD1i12NTEuuCYBzkN1n3+ZDHO35CvHd9TN4MFnB7Qa7EclDjvr78uc
HqqP/xlaz8LZeVrG3ly0CQ05pj7f1ahLd3V77GeZYrfoSAEriQ5ykJCBA4E7tlOuxGla4v6fLStA
Z11njwG1ID6c5/6YJbsyljVIC/fWuUnuFC8gdW+XFt6+7IYg67ee+8+EFDDzTkWmBivl8VCk4dR9
nbItuoUCXZk29vjYEYTbniFxW8JnhANACOQvgbO6QlFoHpTt6NqTVC9fZrqbvNyvxn1Pn6wh8wf6
zWRfp0KCHhM5lnOb3AzYelpqw+pYLC/bUz9d0v3tXSpc1bNBcZ6rJl2sLQUGZY10g3YvaDK9ebbi
Lx0LNfOlT3a37a2/x58KhJAmYBSo411pbrKuzydnxi5qabYbmikcYwu1kfHBXttGCl0yPPH8/WeO
j1QMfch7U8cOAtcYBbZ8kAxHdJc50BrB+QZaCPwgl2evLhTgGVQ4HR34XmvYWegCzurt7TkTn4Mz
K1yIgL1s9j0gBREdUHiYn037WFfFDgw0U/tSD89m/hTr97mh+Q59pQSJre55YtuqOtz+EOFmOfuO
dbbPPA24MHQlZviOYbmvPnt5MHS+amxa9952ZGOWzSznbrpe1cc8h600/aZAJdH6Cf+ZZV+LmUJa
8nNjRWze2fk/brMbHOqvjbemjBlRGOg6wO8BIA4dMaSXLge8sHpRILoG4BQoXNknde6CnO1zaKpb
wIV5ceY7junb9imXnUtRqRuP+rXRCVgOA6XfS9PuQpcMRHZoQCrHZsNMzX1mw/xPbtEKqir6L9tu
yo2aajFkPFkOoHT+O5v19qXP6u9j3smSKMKlxy5HQh+tuoAZXH6OM06gVVyb1lqz3UD3JUozN1Tw
CsvaYlu2RdgPstffe0Xtylec2eQOF7wwVAgdNOgBvvkIoNNmKPRNWbcbV523ChtCs8qfuqr7NuXx
XiVZCFcZQnjjfjBkbNyy4XOrYbuDXo/rS8CcHV9z0KFsHwqn9e2s3IzuXqVfbp804e4/Gzp30jRl
qJVBh5tUO/h99Jfbbvp7dspvt83IhsUdMndIRzXv17i13deGF5b9Z8rgweImSFTUuLDXbhtco8Fb
S8rdZ1YNbYFqpdDKkvolbuqf1TRB0Zz49cxG36Rm0NfDBoWT/QfsIgkOlTDkw+33g37muVzFGEsG
xtaIpf2DVnb3tUrfTAs4lbI4qkp9gLpC6Awf6Ff08MTXDeSWwJvNA5qIA9ylVqO/WPeKfbaQQwPM
HgNMhVoyfWbhjjkztS712QhJqhEIkOKwGOW8GTTlWVv6cMgrCc5nXaCrBUQ3i2Op6PS8qiNVE8vM
RoWZomaQbD/qQDFUm1YGsBHe22dmuH1Sz71OFQ9m9Jh9KxTzd04cyUiEW/HMxBqpnE+YkcTVuMCj
gWrxITXSe532pa/M1gBsGxoEy/bLUswbMqcymizR4GAYzU06WKwAeLu0nIDdcxi7OY+stggmKBXG
jSQsEVmAqDlSPwDHXvcCjLTPtcEE4NepD+yR5v/jz3PeyWuVHMkJ/LxS/TNn32IZnkb4+SvZJiAQ
eGzwxVE2Kvj8BZByNII/Zkl7whGSxBei44Iy+38muCGgr600eg0Ab9MNMyuohiCVzZJog52buFpm
wrLe6hG1sfjogdXLoYMfo95WrXrSZvEL1+iTksiEB0Qn1ENBDEVYUC2C4u9yd5FkSdo6XZBPypCV
W9jGMPrPZpk8AtwsmcRrU8iVA46G7gmgufC/S1N1zAoQR1d5hC0IyGH2T4NIpIsdyE27dnjbgwti
sTUxjzDbMMAjq/OIYiWrFi/XcvQLt3OwLD+BPPCXOfcVsuvGL6pGcYyQ67GzTa7IXqLCgYIv0UYg
CMW0q+inZ4tuxjSNUgjvBBQQ4kAdqbFDhNZqvg0+G5nF6/2J0aJYj5c9sHg6XzuaRkCVqY5HfTMq
n0AK7SNTjUSPJHUgHNfKkY46LboA+PbEeFziJl8UkJ3NHvQPrHZTauZd2Xv3+iwjVrs+DhjRmS3u
xNm2snhWi7uwcHJw4yvHotLDYfa2tI3DrIJIM2tObTVI2jyFQ8Tdu+4YD+xN3ClcCpvaYHpAg2Rv
hm09oV81GX0vY3cF9Ekl4Y1o1aCnC+VhoJjBE8rdKUs8UYvU4M3R6U9vBoASJ91RJLHMtXcEZRLS
D+8kiFCz4mJRvY21Ju2QWLJmSPZ1RoPCWyPjgxIZ0VdEuwXwP/YgNxJH7+fRZAiYiPuCTgvfqmSc
A6K5OrfABSzjaEFMcuUqWUCLUxNU7xH9ZbGxue03xGZW3CyUe/B2Xf9+ds0neox2iB6VwyW+a5RD
bfvTGNw2IXRN+js2918b6x48swFyrkRtGaLaGVo9kxd27eeqnUM738X96I/6KWaP89T5mvl62/I6
R5fRGCKIM8PcKoHWUSsXA8+S3Gg3tDL9VH1L0XBKlwJlTMiEMdm+kE0nt2oK05J2sGCRZtZrX7W7
ZijDHBRpkpMkyHlcDo27xlKnA8R6hqGq2jXJqwqZUI/sNf13mn5vIeTXlMfR/IwORd807ipQcpv9
EBj9wUlfbs+xyIGczTGPYyFOm0I2CeUKR21TXx2tZ73u74q23PaNTC9Gsp4ed6FmTeJ6qK0jy+89
avM90vueWvgxcp728ubI2l9l+9bjHthZNyQmsfD8W7ynIvul6m0IYVKf6gmafH/HNThAoDM8ej+0
8XR7UqWmOSeWQd5E18d1VptQJV8AU87or9GLBhc3evxmLA9Q3vDtsfzf3AEPl9DQpfN/SLvS3rZx
rf2LBGin+FWS7cRJbCdtkrZfhHTTvlAbRf7691Hue2dsRrDQXgwwU6AYHZM8PDzr8+SJhiXTflOO
j41xOw0ra5sv3ZVLqU7bsfS/lxJe0Utum7dxm9xkieFPQxEORFu5KcuW+h8DRxXjI+lkRTYYmU6j
8Ru43b4Yv1w/q6WH+/wCKEbGSzQnoy0sqGa5fqIBGakHUO2Y9oChSO46zTsMdn/iw1qL5EIKbDYB
CKCRgsP61PHsqa0zrSzgnVhessuNxJdGuevGMeBVHchm25fbPjWDKJv/lFl3Hv9jfBL8AIAEmACh
QMJfZXyThtE5E4gO0eZ+mKLQjfKgFp9c7bPA3Nr1TV5UGmBLgsNgHqNUu/WqOGvGsUGwwIEdZwZ9
HdbxLnFDZ62MsWhi/hWkmjObpPqUzc0BETBdjJemHv25B7GM7037N6mfri9roWgyb+E/61ItGnPK
LHcqKI+gn4oKrW1l7dtoN2z2uvWzIw9ldsPX+LkXLfaZTMWsxTVG/mskzoBDS3bMuzeZ43f9g0NX
XMvFm3cmR7Fhwkr0xKqQosaACfde2PTz+uatHdUs/8ytsDOEx8zEOtqp3QyN6VuMbMhIQwFkmdas
w6RFWfu6zMX3/WxNqrskqFdVBO0pjnuT8C3aaEorvC5iVScUi1Uxe9DTEvvmSHmsvDSMK+exs9I9
cATDEuFko+s7VMFvjGmNC2zRlgE9CUX0ufdGDasqTMrqgF+ELau6gFT3MVqDwBWTfIqycetF3+s/
Z4mC/qOCBzhkVIExtnZ5hmiBNhM0MKWAzjC2dUnfeJmFSNX9ur6ni6qIcsE8hAqSJbUOBVw+e/Qq
WKoiawJO35o19t41Aco6GqMepRvj3ey18nXirl+68ffra1hU97M1KOruaRnvygoiHEf4VvrkSW8X
j8yv+0cje7GnNRdz0UycyVNUPcuJjLsae8ZMJJg+J1zzOd0O3Vqgs7h1yMYBzdlFOUhNHiTR2KfN
BCCIbAjAsBR5u+v7tnhlz76vmDtN7zNBdXx/8IKYP4GYas3pX1oBEi+zjzFDIqitf10CkEwqCFaQ
upsaNRa9C/98DecSlDUMQhuSXHh4lQBcQbEQ2wJn4/h0XcrSI4uhURDcYspxbhq/vIxyaEjWVxoe
WcB9mO2wEfyrFne+tK0g726vC1vetH+FKW5TjcA9MzsIwyT+tk2Pmjds/kICMgEYhEXy5kPPeM8a
2haeC88vo345oNGv9f83CcqxNGnRl2xy0tNnKp8z8nL960sXEG0AwHdF/ZwC5+DyOCICWNQYbbGn
zq+1G8ED1FSntTGEJasCpEgTSRmUYD6Mzkp7dNtJALoqLX81JYxjmgZAXPRz3Pgq9q1spWNjUcc8
VJmQbMAwl3rbKYt5SjjkCShWxL41hh1k3pfasEGC/fX6Bi6qGDLkM9PhXJBRwsUaPdHOVCETxIwv
PVp+fl7//OL5YMgZGXjQuIA74vJ8WGRpRZHj8y53Nlo/hdImwDdPA8ZXJC0dEjAL4OabMxKv6ukz
FK7NQYdHYI5O0PEsyLSHqr5rWj7XIQ9Jkv+FYoNcCcPUug2qChVZYxDeyIB5ifRWFY5+oQfXd85c
XBAydO/cDjPTzuXW0bqIorLO8lMmBh0TBgUK17FEqthyUN6cuAybFGBzqL6+Guhr/zZWQAVInIht
CsmRu4lHGXCnN3a8y/hGA/6ajynYBvAjgh9Tt+G+jDGBGlHjp12LGmNqTRMCHxmDRBqdUC229LDQ
Bu/r2ERyRcMVrQOuGUBXkOLEf5E0xijT5drcpOwik0/VKWl8Iv1mCK9vnqJ2H74/7+2Z2+vYuR2T
kVenqQ298al2Qrf93Dk316Uor+YHKYrxKarJbQcxggyaREHTN36l62Gnff+fpLy7wmdraSrJ3VLD
WnIWdOxpZC+R/Wc5fHUhqhGwekCKEwkR7LfhAd3kHuRBpre9vo6VM1EHvj2S104hcOZF5KfW1kiP
xUzl9j/ulmJwZFl1CeVDhTbawMnQn+lrq7nalXM3lHNnIPFzkkyvTlmr25vc1gCJHBWNnzWetfHc
bvRhLya/JHoZ5JPmhHqvY56gKopN1XVvLC9/GIn3hU5kDSty+ZehRgHSN3QcqTYJw80mUm5GdcIw
llcH2owks3K1FkVgZnbGTkIjp1qfKO3GawiF0sfRQZaPjfW1NVfGRBatw5kI5fYCb05o+QgRCSYx
Un81UbK8BIr0IBpeEVopOlIC9XAA+ld1alzwCUYN0Dd638CDfl3hF5cBdwEzVaCR+PCM94hRc6Jl
4Pj0kk0z3VpAKLou4R0A7ixP+J+LeybCvLRz3RCj8wvtWifTysH61bri1uvAXdaa/RAmfEx2lqie
eaVlQS8b/pC7U3njCN6FZoZMtCcyDxmx5BvJK+pLpxkD1iU6SGniIpApqEgEm9LNIKS7IXygweRF
IiTcHnzqZXg7MKK9smlLZzMDqQMnC3CnH2Zb4PhIlKYw8Ca/mMknp7/P3JW3Z02C8vbwxHO0toGE
engqndM43PM1DP1lEVjFDCiArmpFwQaSpXatjeVppN/17IWPu7R/vX70S8qFOvI/Iua/P3sVCl4C
tdPg5Ykb+7x8a8YVdJXZhqmahVFYOG7IczhIQFx+X0v0wvXirjqJXr915ykLSUNqvAjnd82fE3YA
qMuKNi89EOcilV3rJNH6zGxxX2J2P/Z56MomBB/jvp2y5+u7p+aF54sDz8ogugluXIQNihLAc/N6
cwaqIYLdev0dkLR4fI8x7qBK0QdYbbv2i9M+8+y+HO7cafiztN/7vQUsMab5UJafZy4vd7f2OHhy
O6BUReQE6iF/TNZytEv6cS5BsaEDfO5IjhKDo1bYyqBfy3ysfV95AwECEdmVwPf1bAyl1GA/d9fP
aEkdzlZgKv7v5NV90Vt6iXGVfQI6MAb2tBRdVbXVh9clLV3Xc0lKDNQJa5ysFKeRaHJTm+7Gduqg
MPmKaVtekDf3VIH8Cw3fl4ee6R5zRtfC1GsHoojH2LkBSFKxhp+wKAVIje9sbejiVRajD2Wfaxga
PmVu6pv1Wzs91frPQTxd37PF80eAitHkGc3NVeyDIBXv8xJ4KfILHpdxDQ9v8fNoXEFYDxIhwKte
7pUdxR3sQYO9ij9l1QHhxMphLJ35DOAAhhgbTKmqAdABL9LSqIePQXfc24ChQW9XFHhpDRhy+ef9
V+wZqDjtFA9pdapbuBndcehWbPTiGhDvopUaPRwf2rTImBdTTjCUnjlvvQCEZX2rA+36zw8aVET/
FaKGHyPTZRdJCJFGjuBTMwI9tse/EoLpNLT3oBNMbXKt2gHWuE4qAA+P/lFHH+/1RcxXS33NMND8
z/cVa5hFUZ81HSAeGriT1W7ytlHIh73x9bqY5RP/V4xiFHUr4gCKwzKG8nuU3TtrkFwqQN/7u3G2
Dk+xiVVecyY6rTzlUX2XllGY23IjreypZEboTMWGROY+j3QSmHLaJG6/oXa9ub7IZa37Z5FqJpdY
Qz9EDbAJC3Z0QTYjome+CqCzuJMYiAEBKLqgAIB8ef+jWJOA1a6qkxOlWxsYQ5azlphcXMeZiNmQ
nnlQ4LQ0EWXA3dDT1J+mAX2Ve7jrK5q3JkUx+iRLxr4ZsRDKWdBWgLRN6S6ettfPZG27FP02Y+FE
ZtJgu2QIs4/s1/XvLz0qwJP65zgUxaay7bvIBXhgNb3mtADczp7Wn/Nk5f6siHFU9fZKBCkEy8jj
5DBT1EgkuGzz+2T9hf91th5HeSQdy9MYt7Ge1opwGuk9k9qP61u2cvCO8kCmkWs7XYO1tEaDqRM8
9m0alpm30l+wLAaJabjo3hyRX2pxCTGlyeGnG/WDlLFfmJ+NNbap5WP5V8asfWc3xc15b0WSAbvG
dP2sBxIQCWKMCNh8rWV1WY//lTSv9kxS2rtxIxKsJpJfM1177WXyV1E5/VfEvNgzETGhLSpFEFEL
yX1Egk99TW6un/18HT48N2cylOtYGQJwIC5ksJI8Y5LZInwz2V+T6h5c7MGMjmPxlVGEZT1AQDjj
98MlUzRaDLIxuxgvnBttBnObjrvi1/VFrUlQFDrWZdoJA5asKzfTz6Td9tNfWJmZlgaDLihDfwBb
jqoJ3BAmbmVu7KK6ADD2gVabuFibc1nSZ9AoAHIeWEkgrVJscoP2XepWHlbS9T7o+wKApQED/h4d
Lde3bEmdzwUpesBsrR+cxoVZ1u9b0gWViFe2bE2CYpiB2DsNvIYE6uwn0Ha4f2FezlagBmFRq3Oz
MvH9nvzQzVeL3bXjymWZN0G9LOciFM01UwOIKiXBna+3Y4ncKaP3HR6xQfuKwCNgw8+/OJQZARd0
ROgIU9FTpEu9kQwRrNn46oBd3K5WgBaWnE24y+j2AnQ5/YDZREcgR5S0rEEe2/r1jJL3loyYbqTf
q3ptGG5x82bWG3QFIJvgKuafc8PLMwcJX5PcZV0IDCztLd5Zb6b5N6p8JmhWxDOzaaVZwzMTgrzW
h9M3yc31U1lcCDAB5pgM46oqLLOZOEzSGuBlhlWHkRUHRXOqqu+C8EDjN1rycl3c4r0BU4wDfF8g
mJLZ2J0tB6jzuVFXFCG/5TfxMylWlGxRB86+r7wyeelaaVTNTnIKbL4Aft9Etzk7NvnKvi1ZZdSl
/1mIYsts1G+L1MFCaozq1PETBhH9OlmpD60JmQ/vfLdSD8AFBEJa0T6PY3coBPAbjLUocOnZRLgM
eBIbjxjw1i7FRGatG8wqUSES2TZPbnn9U5fllpHaT2gZdE61EXm0YkEXH4MzoepJ6QPt9BEPZ9U8
JqIMBSYrrSrsjL/JMs1kNxg9QjMX/n25upbSMRpnDe+Ng9MdMHOUDiuXdHEt6EhE2gfwWiCjvRQx
gXaxb3SjPFUoP0X0vmW9n5ZHbw0Hc/H2nMlR9IG6Gdy/WgCVVwte8yb8i7t5VgJQ1ECPRTR48YCv
M+N+ssVnzRMr/v+SQsPP8GwTO4XOXOXZjGujHwmRKGJNFbiu3qzO8lHz/PN1AGluHp5EQx36Hy5P
w7M64XY1vEAvqh/1xr2NvWrN/i+dhIUUNoZSgAQGvOdLGW48gIssYoB79k25c6ztny/BRv8RqACQ
SfwwqtuXGCDvUa0HdshnZziaK8ew9OvnAB8TcehuxFN5+evHEuRGGNYuT13hl5OfryX51r6v3G1t
aoqsiKGnToEeTd+tVoJ79fsYDcGUFsIuis48sMoqLjHed6PDOF8/s477xPtej8nm+gGoN1qVoBgN
K5u4ZzRT/5BzIAQcXPrc3ufO7roQFSUB+w9OtvnRnVmMMfSouGCTRgW1eNo/MG4czSbeiij+bFjV
rsjfyviTl2QnEKuh5mfsNe3Fsb6Ockh80Bes2OIP+a35h6CZBoVZAzlfUwUIKtKuNibiDQ8Ro4+l
Tt/6KgL6PSAo/SHPdhiFvp1s+6bM4h1h+ncL3J+YT3XXxi/Uh+j9ZyCGQkscfs8Huh6vowz9V/gZ
Rjxugae1Gzs7CXvBn6cmKXw7R9nfc8rEB4h9HF4/jPfcw7k/jMtguzMlmmcA+pCoE7GxFRXo0R3a
B4k+UPAgDeWedNVDKz0RkDTaaa720sS19wBMh32UOd9aa/xlx+1PYxqex7gGqzGNPoH3DIwWZqkf
IqNvty2KKZtI8KcC5CVhYfAqSHsZtql2m4CrOpmmbT3DKVN5QDkzIF0EIIcUFd6p2oEIYf5D79uC
3jFZ137akF/gvLp3RiMLhxQoLl6cbmXj7FJS7oBwl/odi7d6pt9SE6VCffgEuNYk0EjxPTaGfGXL
Pl5DeHB484Al4II8WgUrpEMkLU8W7UP3UsZ7K14JrZXPI0pEQO0gsgaJwAy4qFipJkMQ54JO/KQl
yY2pVzVmiuBorxw7TN3ZqX8Qopiqeio0Jgt0e6GNkeUZSvOJz63b60LWVqK8FoK0KUhlIETzK287
rcHPL34ecxpw4zGD8mHE2arogPvR5kh/u91eZ06DOEHLVrpDFJP4n53yZh8KGMfkA4ioLVobr3ac
n5ie7fVC88ux2gDy2JeN/TeHAuo9wCnDtCBQuHyfiNfF3Emc7KTbjbiZ3AI+G4uIr5Mmvbl+NO+D
cqoCAKgM9SjY4FmNL2VZBXHzQrOB5t4DUNiRaNcrJ2IdHbuaQN3tcc/3rApdRTwaNp2MMAo6dd4X
bPVXXfRVoI92HXbgUbsl2mhDd0bp605jYZ6Ttge0zrahpWsg7+pb/qVI6/wubVuxh7va+jFqlj8i
oY8RSOpa+8iK/qs+iuSOTmMZYkQL5q5IgbxuD96Dh5HyQCYeOZVoTg5cUX8B6cz01OrV7IEMXzBK
9iZ0kT8ZMVDbM9Omd8Jz800PIGEQuWFGQ+TfdcHiXS+zmdkKiFQoJWNUz5w+jUmb3YzWYN5PxIn8
Xk8dXxb2gbPYveE1cfyeIzVEijL1+7H4qlPxLQFbUgA0GLlN8pdy+uzJxxoeCyiLdiBPFNu8HQKg
8sLMRRkPOdCWdD9Hl1YyiqCOnSCqbX9EwXbX0LIMWQfUdqu2QG9gY3yxtoo66Mze23uArQoYJuq3
WVOzNQOgXB5EPAYeXgu4ZhSITehNujz/BleHIvstDvFbY914a9136sTM+/eR8UB8DTRBtDwo3zel
VRV5q02HwdFPljkAegU88IAPeMIEJ+AmW/ps5/knbYz3vcWfr2v3bCLPlPtduDtHdUBdIDChinVj
3OojrRz4YcAWVvqhtb/Zkq14D4qQd8OAdi6UKUCB8ZH6a6gLOeQjZn8k6IbMtgyk/VqPKyHWbCLP
VvJBiBL61ENhdkUMhyg29cB1jRezoBtZCjAS4MEb10iNFyApwTyE7mxMwM38i+9sCWehd9FjreiD
yE6Z2Y9+lUb8RBOtvq1dGt3VMAuBkYhpQzST3hmDnnzqGHAFgkaf+AO4CdytxbJiP2FWatfHhbXy
NKqO0qy0cwMAwii0KVMVk9oDlNhQZLU4ZK3WYHhEnwLR6i3uJzH5Pulr7TW37fjJckt2Z4P4cG3W
TLk178cBalwk8tArhvkoxUI3hZeDWsUtToZ4Bax3tKK382mqp332eRX7rzAwty0TfF6kezbtgTNI
nO3YbKz0R5Wu7OWS+qI5BMkPdFyBvk5ZSjfVOijQQOdRuNEpJvGDK5LN8KfJ7/cdQ7AIOKk59P2Q
nRyyGh4Y7cHpMANvViAjsMOkdrbasPKivWcb1M07l6RcFVfPSgAnDJDkxsds4DpSuuZtxNvAEWkA
SMUwR9xHO35jEbnhtD8kpvXqJlNgieamL8pQ42bI+ZoDsbjRzjsGOewROvgvLW1i6l3EI16cWvLD
tr/R4ZfT/Lpu75asBEL+Geb8XYRi7yrLEKzJRHEqxVvffYopoqptlD/FoP28LmltMcomF2AfTkyG
xTi28Gl5208z/cGKZV1yucCWamLoFYCbwJS73LFOpqB/rrripGPoNprGgGA+LCW3ADZYkaQYlP/X
zn8lzff9zNxprt6mUQ1JQKTVA5ANtUGWSmtvRlm6jSwY9bQ2Ez9u8CjrAnANf76bgCFy56DPhNev
3EHXAq66oCw7TVQGhV6HqQ6w+Pz5upSlRb6bLCQNEGCqeCJFFTWZ3WJSLbXdYiYL4J8x8/Oj8GTt
t73tHuNyGHcGYo57162clTUu6CYS7IhnwHM1h03KYYIzr0HusJznSoCD6ZTevYyy26hybljmvla2
trm+2vd2+Es7AOJBdCeBRA+eh6cr2YXIAhM3HeMJMFymX+XTnZu8asTYZt0BiEFaVG665AujrU/Y
b27zINX3TfvDsz4hGPOhKuCESI+Gt9Zi9tG2w8l25+4s5C0AhaP8LGIRLYnjSBwq43XMm43LvojU
QhfIL9nZ+4Y+Xd+Gj9uO7Z49IALVcuD0Xmr2xNxc02xdHJr0iZffWfm1oDh7Iw914+26qI/6dSFK
baNA3rOtXSHFIS8jwBRtabbJAcPokechPjERglP0usCPrzAuDVKdmMFDLgn5zsu1GYVmJpmTyENp
bdEOmqy8jIufRwyBlAL6Gj/06zeFsIRwCnlo4yKsjd9W9On671+AEsEC0HmGiXAMqX3opCtqh2Fq
VROHYTrafe4T81YTr613yPttZ59K+1fBH4XTrxjvxYX9K1btrWskoFOaPJMHgIG59Cn5C9AxChY1
+Nyg1l4Y1hhTp0hQXM2Oed8GNrtL0xnPfae1Lysb+O6dKJf8QpLyDrmuGJI0z4AiXIHJwQJIytbh
yNDFrfdcUoqAS9bul9Yj2W1ZNPZtbrtNOIAE9VsVyfY7IQxMDA5+nj6RbtsDEfzU49i3pd69IAh3
DgC0Ak1MmrsbYH+iqyKKf+YDcYYglU70Q1JdgK1+6rZewYYvVko+Z0NtBk3nVrvYscfPpTFl0ybO
aHpsa9P8nfJ47G5cxAl3QOhlz9rYsqAZXLr1eOTdp2UzPbGybDEvp/WPiae9JCSnj5OplRta1PoO
s0wYn4urPDnw2G13wMRwcr/tbGtDyqbx0Onljbdjl5OAuImG6H0AxFthxrE/Aq9wZ405AGAHzb7N
YtvaNl003JXJ1NxmBnrdYjbKve3y+Nau8dZlsk92GhQG1QpwinQIJbdjwcww7s3oZMDdx+A5wJpN
W+D56LsuMK00pj6CPe8Lr0rtmGStYL7DnfE793ix1+XWa4ffEW3fbMBT8lS7kZkVEtBhPSWZ296h
KvaYaL29qyY23GZujYbCGvhQQPDVESQzEYyN3QcEvHPHaGzawwC4hK+OmWo/a2D9btMpGz/ZVNPu
JGUyEFZPvjF3HmBP+/LooJS4y10U+kocrAgM4STf2sHwHmv4AKDkS39KsAFvO4nJSgzXpNuyYd3G
pAnZyhT92ZREfI+5eA58kzK64QltkB9IyQaYQABnq80JFco8uwWqsYuv8DFoJ/P7UHsVmFmEDKXj
JSGczz7QKkDqBM96agS5NuVPek/KZ1m33hOaUbKHBCTkfo1c7F1FYuM4RgWIiqIWwx3GAMQsI25e
WTkMO+EVJChcWe9IETkPhhUD4hdYsb6hI20jzK4JBl3moBghmDZyCrIvnMp604Wl/TZ6+Io0A1OM
iwribVvmw2as9QolQowUMl5qfubxbIMIS9t4ou63RDPG0HS64daNaqTlkTDekRik2ig7S0CQGgyj
PNEYmFlm7lybwXEqPWfF7n90PqkLTi/MjiNpjd5dJaeQD8CGNEY3Oc6Q+nXZ7anVPElr+uOM3ywG
aThUogjMv/q8DE6GXmcnORLDCFxcyc59ZgLzq3zljV6wxxeCFCPGcqaJ0rCT40BfM1DDFEDsuW4o
lySg4wCj3Z5LZmDGy5dSMNq4NSa2joYx+Zqj+8laznLBrQHEJJL0qF8s1IApuii6DC2tR6lBzTwJ
frTKbzXNR+4xBHd3YE4rPUJLEjHCi/5DYBYCGXnWkjOfvRTwddOuwfEUHrmDd0DupaPLjVExekga
18t9veiST7I3nZXt/BiYXL5vilNlR1pD2jbPjhjE2pr0C0t3NJ7CiP64fmxkwaVCPR3tPOBuWOhH
RuI8nvJqSo+TlbhvzCFZ6aeTgwKM5Q4wwkhBD3bkbYjeyxt4Mi6U06Rh47J2T4yc+lOZa2E3fkP9
IHB6qj1MbVYG5vC1sXW/YqTfDClocrjs5Skpdf7d62CyTDfddj03gw7FsoDp3D5WSEfsvB45n4yD
PiMbyi5kbVE/9FFvPQHKge00U0bbMbJZOJmSn9JB08KmK14F7dqb1EHWU7MzEo7DCKJzOri7rGyG
70NfVNvSpT9E1XR4f5CrITKlQU0j60EwJJxb6m1NZ+iedLRObjzqMSAu5u74iVl5cYPijLtp8/53
2Vn0zm5RRrKEPuxG3Fi4oVqbBGUBizSBnA1QRDrC/cgafdKl/e8+NWwfk0R8F3V6c5PkRbZhRZce
S2NoAoz0skdeibUR+6XL6JmzTQHULRADVLuS1oWGElZyxANUg1YUiPDo0Fvx8Rb8fvC7IxUAxxXA
BGpe34xiYL0KmRxNHlojaJk3MguBTpP9YbsBQmfYkzNB82rPrmGUZprEwwZB4zGyU78qV8KKJS8Z
eVXccgysYapRjVsxWCzqpNOSI7PkIRHJczHw8SbJ+G+Z8scocVCnMB8ASXzfJfxXw6aVuNnWsQTF
yUSODzuJAuk7RurlEsk0ZjaYe6MDkbVI/cQt6a5DuvvZMUvLZ3USh27fFTdj5oiwGwi7b8ui2/CG
d6dxYtlX0M8YD8Ryok1hiiyQLnq/aoOUIR2hAa2Bxvwo0ulNG3lyi7f7N9Cf2QOjRXcb93HTAmbK
KLa5w8anqpDuYwJc5sDoCnHPE7P9ZGIABf33ZApRyEGBQtJ8+ipwKo+RGMlj45Xx76j16s+xDid3
xUR93Bt0lOMhtuZK1Qcg5a70uhGAWJiqt8hDHSUVMBDNF0HYnlbFLk6ix+vyFrXh/PFXnrJ8YmVV
6QS3pyH1vZv20z1DynHDncHcyMrJ9jGyAqMPN5werd6ld4NMtD1QQqK1IYul34JWXh1hNcq/c1bj
UjEKMea6hyrwwTSY2GXcMp9LjF8+EVOWt5QBL8lF0v4uwYFv4wx3PGEp3ZrSiH9f35UFk4LKJ3B5
kGB9p2G9/CGGJyweD8I6NEWxT8t6v5ZVXRKAroAZ2RnjGEhfXgowWZXnsYjJobo3nGO1xjaw9nn1
LefalHYWmK/6cV8UNyg9Xt+fBY8RnQ3//vz5QT8zUvVoFwYws8gB+dBq/KnR3x3bXBfx3pOsWAmU
IuD8wM+CwqngmQCysg1Rpu6hIUUegV9DI6A1S4eKgXKDE7YhsVU/zrkqsWMpYBJRFm32WgScsK6N
nzwj9uf2vW0+kvox0wx9M6Ka8pazSnxlKSw9WpTnBLbh/OFQ7WzCL365sjug0c2KHHDTB0Ke8tu2
/dN2KyCtA7gOk4JIRCHLqRyuV6FwHtmDccB0cFhn3T0isdfrm6+cL/JbkAALbUNBKRrTlIsorNoQ
VJTk4CUmGoZ6NO7qScThyIzDiihFVWdRaPuYx17QrqOjonGpShgiAChKIUfEijEt/SKxh++phgj5
j1cE0wIQfodiZPdDh91ooigMH2tE6RKgOhgQH8bXxFhzReaTPdPZ98XAAUHrs4trDWrPy8WkDNGj
Uwl+iCZrU1jP9pBsXP2+H9bgxRcFOTamg6EJKDcrKma0fcR12fODYQzVbdMIbZO0YI3svOSrgXsR
/vnuoZr1jzjFxWI1Aey9C3GMZT4863CSMcarf16Xonjn/9k9RMaAI0H57MM4vTlUZDB1jx9Gznw7
dXdoGLVt7mfZWwdQM2q3gILKt9eFLqg6Yl4TnS6GZaFqrwSLBAxCU9VOEDq1/mSe3JYB12al3Lyk
5ATwbJgjRklCV0FzcM16qwNW08FOiS9folVkwaVVnAtQbpEr2GBDx/lBf0kmDNttbaNYuUGKB/x+
Ouci5jWe2fyIFKIo0NpwiG908N1pPwMZIaPy/fpxLCk2ULgwj46yAOaHlFCw0nu02Q6QIkdfo7vJ
792tu4bDuLhbcwyIzkDgpVnKmceEDB1P8vGQdHSLpLQv4GfZ7q/rS1no1UDF35gpmGETwMOs3Bq3
91qWG+AxqDpczG1qcX9EhitB28sduj8n+iLWSPWWFO1cpLKyVAOwnRXX40E8WPWGVzfXl7T2eeV0
gBiTMdPDxnXxYy+PaNv88+8DjnHm94aNRmn7UscarzaNZCiHQ+P1fjJnlrsVCUtHTwHAas+z8B+5
K1vwd8WAMRwOSfZsxm5YjN/K4stfrGKuo8zthtBj5TLKnAjbcfLh0PlIpQQ22uuvC1hchItKB0op
qHaoz0zPow6NmPp4KE3kTm9zuu2r3XURSyeN4fB/RCgPzNC6xMgGYzz03X4UN/0fr2Auz6BqiX8w
9KKC4TajnntZ6w4H2tf7pu8e3O4JfWd/ugYDeCAe9AhQBJhDUe7fBHxPo+qn6dD0e9SdEQte//78
/1++9vg+wC3QwYgRRNBjXGqrwUU+DOjrO9hgmxvd3wOS3YncR/a4KexipXq2KIwgaKdAD0aeVlmM
l9haqsfldKBGdVuKBwpAZqGnvt47vt7trq9MjcTgV87jVDPtDABS7Q/MIhpjyPfAjT1aLNkYmr2D
Hd0CfPDbZHa3Y938ah0HMFQytFl1bw6/r4v/oN/wakANinQx4M+wZsXMIJdeeACGro/6YzcFoA+P
s5Wj+6DelxJUVMbK1IGA5kJCM1LnqWeseptyc1xD3VhcCNrH4EjDefowO9JmcWQlRlwf0Zhd/ZyG
X663Er8vLQR7b6IAhM6OD/2m40ALJtuqOdoZBSUlB6mx3oDA9fqBLOgDbtHMDoTqrQlHXckSWJOZ
5a3RNke9KA6RbiIlmWxq+mJlz1Vm33vSCBPDDUVFQ96X4XXpH9aIXIBpoecA9KYLaQHBXU+yzJDH
rhvpbZdp3ZZWaE2+LuWD96lImX/FmX+jzR1VpTfjkEe7VKDBFAm+UngbVt7Wxc6WvW81K1roqgYE
IvFau5gxRyUBQe6lSAbUabDpVPqRjFN0X1mVPJZTlIVmAWg3arXZirIsyjMBloPnD7GjanUprcBE
3UbyOLVlGvDG2ZCqvKdN9mMo13L6H1R/XtuZLGU7aV1ZVkQT8Jo18oghqt0ICCNXGiuauSzGxWps
6D/s1uUWak3cWqgmy2PBBIAm2j4oJswIsZa/XVePhb1DeAqoJOSF7PkSXAoC6DjSy5HQjpZ5L5vX
vD1Y/VuXJSu6/mF2BniMM2YwXhNAJqFNYv4dZ2posT5nA++1o16bT8SafJnLDZV3lQO6hPL/SLuu
Hkl1bf2LLJFs4BWo1Imunp6e8GJNNJicTPj192Oke041hQrNnJejfbS1a7WNw/JaXwCOSul5UNcD
fYgIb46qSrudo2DFcXu4c6L47m6b/wwwMUwkyXOVYTFcMowFap9oOE+d7mliJ4qdijmKkR9gWQiX
qf3tcCufEeFgPgYtNyCpljshoYzg1YRRx+mddIAT+whk8/8UYgkCdauYUIt3JCy1J5J8NtihsU63
Q6wcVJejMBeTliJzpVbdkzBN932+T7aIVRuzZC7SYycusGdrzJJKCk/OVK4W8gr92+1RrH163Ub3
ETcWQCfLLWVpRUYy4vCwNX9ETurr7nPfnnRy746T54gtGYe1SYOv8ewtBjNRpGrvF3wuARcVrsHD
fvoSAypW1VtwwKWDFFxUwEi/CDGP+GJPjUSVnSERooQt2APLzLekz+96YJ1CkpbZsRkH10vaoq49
ak7PhisSWPSM38yBBmhN+pybL0XMIA/vdFs02bVvCmGuWcgQroIwpX3/t9WmLC3BOQ/T6b5Ay3XI
PNvdelfNP7LczTjv5zsGFjZX+uqwqLLGZtSccBThdHrl9+ZWURIpze0YSzsZFRWx1ZiIYQyOHo7p
mPi5Apyn7F0BkgLEn7Kh/FFK290rx+w/F6wqds1g2ifFACJCnv0FLw4AgaT42SAtDPQG9TkNHi4+
rVwZqIyquwIh7gw0Oo+VZnQnkSviK8g/wWDPsNWBaE1xgBCF9iTQSug8R5uVIdAzOAGTJIPKrGNv
zFTtJVDkBDa5rHzDijWP0/irrZi+GzqVB2iaQYW10qDDYfZoQDkksGLLM4Rf6V7BtZeeMTC7VOGL
eohgseb6mZYC7SIF8UZR2F5bg16GPqjxZAIc6iWG3nilbpZe1g31Qy/17MHobXBBh1g7SJcVD3EL
anzRoaNM8vhzlduN7RXOkH1uFIR0vSFOiyAV+gi+x1iTQzWV7U6Zku7aJCqfpdDNoxlT+1MmIvMA
mKQZjB2cDfuax3d5wdJHvSPtHYG1hqdl8Xjf2FoTRpGt+7oqhT8CnHFAhf0tisEu4L3Nd6Nh53fW
1MhjArfGQ5dp5c6NquYp0mo9gEkLg4tJk4YjeIpw66Opjywa85mxNsgJLmKeKDjCMzPf9zTX9q1N
oBsPbahgGET/ULSRdRebrPRFpyfHweDlbkg64wSgvuahYuoCYTYYcLixIn8shyEY6o6C4mhD4WWs
O3ygrn/gTpJ5g9WzgzZp3atDSOkxafOwtiXf93zMwsa2Y5jC97GXluVcV7T0wNKIs7cofzI5CJUN
T2qvzp0EJAxN+3j7NF3derjVICCLQxV8+Pf7OwUqS7WcOSGU1H07SoTf6xn8yYc32RmfbsdaO7mB
YMKLzQXJ+6oTHju0RJ4ieOgOuePhILiHPNojMQbh505xSMYk0FN3Azeyuu/B04F4BRQerxKjMo1B
10lbHhpfHTDAdreHtPXriyuvBpW1IAV+nRXAvEj03LsN+cX5frk6G1GnQSUFzYErHgH8IlJ3ogMP
9Sy9E2Z0SCsZ5C59RiccsuMxO/79iPCSYuCaU9x4yyTcsXs5qbzDR5qyX8AS7moZ/8OQIPaL3jpM
NdCdXay5kTCjU2bPQxCN/NbSHuwCYFj9Z0XbXUS2zK/WbjD0BnQ08y28ZOzFBT5AIEVmhe4CvTMF
ZGrRyZH7dBo3VsJWmMUlLmWv0CCGP+Fkh7FRQRD+hCt/I0lcWwyXY1m8yNrM7B3oZGMsWVj0p6z0
zOGh7AOj2QDDrW3Vi0BLCUjYck+DchDI7A69fe6LF5ahmg4dm6n83dC/VX5BAnQZbbEgJtaSGrJf
iKbcjyaRh5aN9xxH8e2lvfqJoGCBqqRrz+bM78+6RqS4hdPBDcfJL+Qz/MII2Uix147TuROFjiFg
glfIu6jvSsuZZiiC4L7SuFcWd04hfUN/uT2W+UsvjwUA71A4BHEc/IJ5rBc5Iwc4JC9tUH6I8dD2
v2NkCfAlq/nOjZHJaLtEbUGMtiIuMkEDBswdjxDRbap9WYDVWZ4H+hUsL68vjpFRBj3QhrdHuboM
L0a52LusRyZWj4hZWTA5gK6Jlr0xN/G6Mts3aeX3w5b58+oHRCkHHMgZrLUsmpYgOdsMOJaQdAdo
0QaCgiHPv1hb7InVOMBugKlBsViWfb1RtSLJiAvKVsPQrqReVX4VbrPn7cZOXruh5tsDqxHcxSuJ
dZ2ohJgad8Oy1jzD2cXdFiP2uvqG7YsKs2HD6RTAy+VatKmVmrUaWFhbZgjTvEPmsNeqH/CZ6Esj
xx1cr1NvxtcBIBEdXGn+vL1MVjY2/OOh5uEweINfkWxI0guqxxkL9REgjAzyFP44gYTtVJDavh1q
5QRGKBBlNbgHoNyyWJFJ0mjwaE5YyMinaTiKHnlwwo4xQN/GtNGFWI2FUQHwCqoNgr3f4ylzqyZ2
agbgM/Uj7gQJHw/E5g+K94AiJODU3x7c6jxiFtHzgNjXlcu6rrdiaKeWhRI0/JRMrxbRHgeX/v6H
MBA9wfEItCYaFO/HpZWjRM2Ys9CwKuIR3fjcGWZ7KAxabiQzqwPCUQ8sjgHc1pLu3mtV0hSjwcJG
tp7NzT3M4fZ99S/zhqadbuIlj3WxvFhAf23KwolY6HZN2GiG8kxTWHtlRVsNVAC8rg9+bDV0jJBC
Ayqy3Gym2yVQK+hpWM+CTyOxO2Ctue7FovZBJaJwnQWnhKBXEFX1rmLxjjC4PM0apL8yTRWf4gSg
Os9oa/2Yuw0AjTSrpV/r1rlKRH+PtHzYk6qI4QqewdUq7cvJQ3bd+hQ8ogB/1a8x0fvHRq/VB6GK
IUjQnj71VVee4ihlXuPWDFwA4T5EFUdRkKrG16jLoatP8upJENd8NnjU+bnIRh84xgRlu4keuNFG
IS/aBGZ3rdgZ0PhANl2oncgmBXctSl8A8WWnKq+ZV2uWCkpAMT0GH3tw8LvpUcj+e57hL3BiW9z1
4BP4DZKKF4A2wNywhuQO4HTbL/UZAS1q91BWmvnYqgY8nEq9il4bDkOBrEBQ6dw7eR0dIsELP6um
4V6kSYvng+iNT1IcJ2sve08r9OqeojoDCXyny3exSRQep459Vya6PLICT34Y+Iz3ejlp4Whb4zmr
e/cVHRfjvhFU2xECfz9pJJpnDaYGd/DB/pVzDCipzekuyqskSIGpvgM3A7I8ieu+JjWIY8OYNoeZ
4Ll3AI/0bQV3aPzT5JlJJ/yujLsgNdsc8hOm8HBgwD3OaSoPiLRZWXfm1Fgt9HmgkBHYfOp8bJ7c
1wvZBvpUqd/dYJNDzmPma2bs3GVRSR9VRa07IMD7JzYkkS8q036o6jr1uSXJMVG9/pZEGgwgDHMY
vFg5+sc8rfnGZbaSD4DgCUwRerLg4y87yz11SitrGKhA0bTL04+k+6WGMuBJ4pX997LZkt66xkhA
desy4CLpMSPw9YhDaajqsM6+DOb3nD/F0ZGaZ5Q7vUabfDVudHrWDq3LmIsrBnmvcDqCmNl0FCqo
qUfZ/vYJvJIUzPKH6P+jZQA9g0WIWHY2YL7cRvbYBgqHMC8PtyOsDQJACRu/g3oUvtb7Mz4RhjkN
WM6hMn/qHGS1KfNG1m1cWFeaYjhwoUEIEAt6KxRY2/nPuEiDB6NDWgLVhjDJKdmDIFYca2g7Q2av
+D6g+30PWoH5CTLJ0h8B4/TBFqyDtJb5HjCIMsAImrPMWufvHzSzNOLciYEQCSA87/8s2icGWD2Y
X+rAGwt+Rzil2y1V3tUpBgIVYsYGOp9L5b8yofCGS+axV/ZvxzJhjG0yuTMTwAdvf0xrbd/NxFsk
WShFoFf8fjwCVdEkmiYnFI6sYPk09ftOVZ8gJWH4Wmz/bMYiC6ADZu8cqLD4TiWTQ5vLzlOxUQCg
bokn1kG+H/V64OFhgLOv9Yk8xEga0b0xhp0agRLJskQ7EUea4GjXKDeDDYhinDv4RZzpp6K0JGDe
LrsXrGEHNx7EbsDx+hZPEXjVhHR7C9ivrIXSmEC9MujyAv8fry8U+JLh3MohO6EsOKC8Nlg7nI/a
Xmk2MAKgXeJAU7hVGoDsnNrcOkbWtpuDGxuL1cWjf2ljAmM2wyzcGEW2yXmUtTyBhPcvhwZaYZCT
Q74DQeD3X4h0KZGiUTQU1W8lwBUK3OrXxirATyyenHBw/W+IRdpWljDKGVyEoA+Nk4KYtOXKNZ8J
VwGgMomnORR2cAS+H0MveQctmZSii198YT2foJkEuWkea2+0bvDAlVsyeBvreslhZ4NhjinXndDu
aSB7/qlXVRAzQ3hA3x/qUfl6DtLh7Xlc3bez0CWDI8wMz3k/zMIsAFUVFoKq8WEsizdWsVdQhu2N
OGurbtZi+v848+AvzkZXaNWQg4Aa9ijdjLCfsKYtXZCVVyx0pP4bYnEuGG7qxDly+bApIVF031Ac
P9aHCBnf/zRlS4Fwux1FbtUYiqjeOqYjAfq4qbn0J0tfLr+LwSxb6BXw/CnSWycsC9Rx4/w1ZcQz
rOapa+KfSc4+YLSVJyvrmJjxo5SaR4s2GGm5keSsrw9cPYAoQO9zmeGTJgeNlzVOqEjqk1L3M2hu
Ayu4uz2nq7kNBSkeZwZIr6jHv18fdIhyaMH1TqglPOB5dQeBAk/p1tEazS81tX7CrvtYTP0JBL3T
7dhrQ0TigQQEnYBZmPV96FbLTQXuyvw9faL54JFZG/Wx9QhQuIT3IoAXywzHqIspK9zSCVn+pPUZ
5vAlb77eHsXaBkN6w1DBgTA6TOXej0LjraaQP9shmIeR2rdiY5aWslxzY3gGmf0nwGIHU+KWNUiY
KChXT5J8yZzOa4YjtR+05MmBAwPKsb177DvQn+hjVz4OCZwGtiyPV9fJ5V+x+FhVRkg8TBimlj1B
fsCTkQNq5y4pvjH4n+fRL51DfX6jRrAxt39IeheHVzIYwHPheg7trAj7lL01qbNxqKwPDE73yBDx
pL4Cp1VZBFB6JO1QDklYVeO9UwITYRUldAP4Zxqn3/Cy/9DW/Ic0nJ+3186fJb48beYCiD3XW5i5
3OWRrfGG6gVS8M6sNL8Fi8i3Ibh4cjqrO7KqjH1YI+Yf03jkYRPhWdxNbQ66RotqMhcg3pXkR6ME
vkCiVBALHh11ZdjAkQ59kI52titd49s41gytatfddRDUBiNN094Uo0DMSAKO4QjBG55D8cjrjeyf
ThgHpjG2BoADpNPmTXrxEXtMXwWoEzYhNyo80gEcAKQXWDxqt0ENxJ7npE1zn7tTc9CNyjllWlK/
3p5oc/UkQMsRkE0AluzlMZc7kLGgkW2HRoLTuvvNGgKHlJ4ZR9so9X0hITDcFSzyITqLN0pbO/sy
Mwr8uaOLTUWyM2QByCGLOnXuKw7PiHSyyRctielONh1p/JFnroeWFj8KJM84zZh2Nwy8PuioqvgA
kBIfuI3qDsUI68EFZwwyC9R95rwrdiWpzIeKomGcgiXx5tYbZ9RaTnX5CRYPWORTjROrzglpO8s0
TJFXWe7MoPWqxDintApuT/fabIO7C6zIH4+F5WxDTsJ2CQTzQgs6GrkEWYXzoBabioULku6fo/Ey
pV4ko62Gd9EskhEOIn8SdOSeVhf3rWumnjKj566wvxXF8LXl1LeabGNNWVi313vXAfwMF/RMhn2/
rgfZNlONhC2Mp2Jn0m7HzOPfTyMqo/+JMP8FFzsnbmF7SXU8ILUOfk5JE5AMcof53/fGXYjAzuhz
iHVd4W5oFBHdcQw7dMrq1QCPdLKNjRDrh+x/YywfJmWvw2y1o3ZYdOQu7RgaAWz65QBU7w2JCi1d
7oaB3OXQNpii+MvtaVzLTy8G6C5WidVabiZxKIYDxEeF+dlm5wLFznxLvHkrjvH+c00VoJd6ikFW
EOQBgaZ9Kqptb/O1vTyXzVFOwWP8SrfcbiAAT6rcCbu3Aqa1DICNCpZ1eSA3kqfV9X0RaHFoSEi3
qa7PnHCyfBPfydnd/ixbv79InEAFbBTkeZzwcwdCPCBJG2Whtd+HUoiGwgtKIxC6ff85QKu3dZYU
TqjXEHbPoPnYkuQfsnQbRWdgGDSkmUvgjG4NkSkS7NC8CbTsRXxu83/4CijvoBUJ8J12pXhCykhE
TJk2mhdQLS5U5hEYJfzLVKFpB3Gdmb2xxGIApQRpA4hgh43Kj5PZ7l0W/P3HhgAgDrMZ1w0UxvuP
YSQRTG8TF88qUezN5hsXzsYY1vbFnH+jaoBaG4g77yNolRbnkGVwQ6EdXeM73h07mdxZ9XRMxMZx
tna9XYT6c9pdnMsRZJQStG4BIRCPup17Tee15od/mDC0ngG8n6+5ZTepcjXIRxWJG9ra+AwcwfPY
2ud/CAEPBBRHgRW/AkW5DRuFTpUTRhpqpbU3xVtogdUteBHBeP9NIDdnp7VA6lfCUif2/gGQ7c7F
ZbS00UO/krGNpq6H7CAKkqgYDupXHR+N6nB7jlZXFThy4PpoFkYyL4WLT81LvddZxhECEvB+ksJ/
IO9TLdCzQvPrujMOtpHo/3DvY0w4e2dMx5UGqqKtyE04M4TJqDxF7wt1Pzi/bw/sTyFjmb7gygcj
B2tsNld+PzLRtmD/pQ2QHDlacZX7vR71zxO13rK2eLHbBO1fftacNkTX76yTGnwME7wu+D4a6YQO
oPkZefqpNaVCMlk9RM7vSMUQmjK3Xmiri8gFbwjKOShTLB/xjLWdpBSAHTLuNet53GInrbYPZlY/
CA2A0lyB3bRSL1sDLNsQ1lm17vdw3bBO6I8l1gewyKsvWrGHtn0b+xrERtqNJsHa6C6Dz//+YoHh
YT/Wpdm6oSym6rtbtem+ko5xuv215xrB8mNfRlks48xyCuBwMUQKEbBusj29e3anIzQ9dMk8N9o4
vNYIIoBguFi9JvbNFbs0gR1hntQ2CyEA7+ZFMPG7fjgbYOMWaLtmO6Prd9xwfQjPHlp9qyeylojh
NQ3uLOpKQDEsLhvXaRtUPREdKOq9OWW/YcS5h3RjkKXVBml+NbO9jLU84hg0QArlAvYyobmKruWh
FdarkU+vbSuhHjwUUD7o9vagHSbw6zcuvbXVA8F2kF/+jHV5cUcR3KYNSVgYDffNR7PduOi2fn4x
OI2n9SQj/LwFQYo9xf/cXpbXFym0O1AVwPsDn+mqo4T+DsrtQ49nQfkzb3t/yI6U/Lod43oMfwRs
wH+dz/Cr+lwNKdXRBm4+TDxJIVq5cVZfr7X3Pz/vvIv9y0ajEImLnzcj8iU32idRFQ8EUMyKlRub
eHUkeA3ie0P/DhXT96GkORlGJSC6OQFtJ9PIS37enqrry26WUgEdGcgSBpX9+d9fjIU0fUJzqwOs
KYOKE4oE09cBJ58q701nq0SwOpiLWIt5q4oplkoAZWTkYsboB9Td3R7N9Zn3fjSLCy5q6naIGEYj
m3NkB3nb+g1qOegLs+7XZiF9bTyooDszDw2PzWXfYErtNrIHyUIl9YeKu4epf709HpDPr05x6ITD
5Q1lDSQ9V7V6QVCoa61RPLNCq+x9ApOWY2aUXdCiyNZA7a6jJwF7oh1smuvX3lZRIAG1P5UNKHrK
FdPzQCp60qoUtn15Ge0FLA0+yVgOH4q8HQ84wfpPYJLQF6QfyVHpPD2WJgxrpwn0iUprJFycQOXw
OBKKXaLp1S5BV+ZDkzf4hjyyDnyI+EPVVupQ2Kk6prmRBg5r49BsImeXN7bcQ4sWcppaEt0lMAmJ
fHvokjuIbn6pa/bbRvT7Rk+155bVyT4zEncHNsCXqdLaQ53Ogs91Uj6Qzpr2A0+s+66oqPJ4pXBB
q2IM0wEGADRrEn8CBtav0Mvc00h+H8YG6PIi0n1Rmh0Y4Zw8uWPePyRunOxQX1fA5yTl3u01K4DE
XBEwayo+mNJKvQrq7H4xdBwuwVG0c7k09yPKhi+8izIffqv2Gyes2HPZZkdLUXIogDK+L6FxDjHd
wThVtvW5RKcF4CnH8sZiEmcUfpVPBABVegOsrlPr2T2ptO+i16MgbwjaZ930y93ysFjb4VAYmiH3
DO4oS9K63bIYYjW6eOaK7t00uQfFE8wf66MzNodcVxv3x9r5DgAEbig0pFFgWjzBW7vRaa9T8WxH
0T4j+Z434j61twDCq2EgdQoGKACuVzxQ0Wos0iYmnq1B77wijx7w8cO++3vADKoJMLMA4xUjQsfz
/fmoZJSZdgEaXOEUPyzaZl6r840W/to5Ap2G2YcFxVPAj9/HqFv4qMEmlITGiL6jKb063ahZrKQs
gBr/N8Ty+ap3mYVbESRTxUoGfwMXjtRZchSt+9GoujOr7aBrxhMbsFkI3Yi+dl8CFTPfLqgFXLVb
8CR0aGyXPBzsdC/TbyV6Gun4TU4b87gaB5Uf2CVSVDaWJWhIBJqdlk08hJQaIHAfIUXhdfaLlX++
fSqvfi+QgmdAB5bf0pexHAHNY03CQ54CdPP49w6lyGLBhcfrHMsbpOt57V/cyXCPiBUSbB522YsD
oc2X23/+Cmx7/n0bD2jYtKDBt9iiUDFzHaD8SIijwcCKUKafE/jaQa9BPHZmogINeo9eFLXNEZxJ
HeZDg3MEeiMObv8lKxMJp2xApVCKMNlVhaifpqbLjQSrsgnsR7qlBmispANwvUIlZRYmAUx8MdAC
nGdzAN0/HFsghYyYgf5BXeXTfEI3M9XTz2Of54GRV1BwZHbp14rLQxlrFCc2j362uLL2QyJAeWgq
CQBplx7Mcvri1AKYbKDb9jRJRsi2EbFLy+537NL7WNFfXdJZj1NjdIGScYZGENSk/3rmZiwwoAI2
LOYhTLZYImhtuWVV09CBz03LH1r9L8UCUYBCkegiwvztLhbhILpJNU0HTI51FrTxpPnp74cA9jPK
EIiCZ/hilTcWy4ehBdrRQIETOr1bumAriwsoPGemMIPHfHUamDm8vBq0BcOs8dpj9uMf/vqLX19M
T103rtm1+HU0UHLjCVZ+/l8HQPUJSG8wmlHIXt6jkgPVNVIkfja4pdwDhXNjCa2dligFofkDnAHe
YYvMv1NgDEd1I54lb4FVBNbbET60Vr1tA9j5knxfipjNblDVgqUiet7LJ6tb8GEczFY8G1I/uhJo
64jfl04ZoP7jEanBWLA/18z6lrQZbMW0jXrLWq5wGd54v5Q70XXxANTgMxudLxM13mjUHnr11+pt
87GNsiFUcnGoQWTkfRirAmRMQic2hA8psGvmTqT2GX6ex79eGAgD+Ws0tkGiWEIy8Q4xJrvF6W06
3CsAq6w2AiwVTuetfxlhCY7rYX/UpyQiIed9kCcViMxoixcmLBkn6jttft81xKuNPEgm/WDZ3bOi
zv0IRIpg+YnBNINE9cGBRZzuNLski486ZF1uz8LKNwXjAokf9OtQzlzamUEctQK53MHVUT4yB7Yt
wqvGjVR2JXOG/5wNuTcb83HlP5DWtB9LTSfh2L1wDbD2NDC0CqhWus/Gl9vjWbuqQFAE6ochA7wy
IWCJBTJ6nIrnuMRXrX4QhwVRcujiw0gMn7V/X1dA3jzrtIFebF8pGkuo1TZwciThAHM9eax+3h7N
6hJC+QXLE/U4R1/ueEAPikYZUBzpB6rfE8402KeYEIIqYZ4oJ2DCs9Y1zrDBkA/cdlroGNkpwKv8
M24LEUydyXeZaaYfGE/5jyGFHkCZWcrrbdLuzUrZUICvxIfbf/XajYG80QB6e75Zlzurqce+Bq7G
AmrlGaCq8nz751eWLG5UTMgsJYq+2OLCs5pERV1Z0VAy69EdogNlOIag3/TXYeAkwOb3ChQ9r0TK
KryBjD7Fp22dj4IJ34TCRc23bLdWbo/LKEuhMjqSJCljCjkgaGp0vvza9fcw1bk9lNUgEF8xZxVU
JGDm+xO1dWjFhjzHUYdeZYBSSBa0cQ/MYp3pAJzXYuOhsrbhUUBCujiLPeJx+T7elIoer/WChASI
qRKQmd79nSZPbQU3cm1jw6/HQqXcRLMaL6PF9WuaUeY2BcZG5oJCB1HorAuKiSHLJJ6ttI1VsXa+
gJr8n3Dzv79I51KrMEqaYmiTpJ7QDy4UO2z3rTXOcW1AZGLjeF4NBxl/Ct9OmE0umX5mr7uyKecn
bX6oItwDHkwqDoBjeXC9u71IViYS9xUIqHNVeS4rvx8Z7eDpCw0svJai/khE/FVx89CTeFc38aFM
p41LYeWQuAy3XPh1D9n1yIEsA0SHoCnQZZ9vD2fr9xdrMLWbzB4Zfh9ufajHZpti9vN8LJIxkHWh
+Tfr5aFrvjiG7FYzG33WeRgb66dhBwBhwFhZ4dmzw2UTJV7c4wLv2U7L3A+GrL5qmfKonuIZY78N
ff8A644j1+KNvb6yYmYOMYWGnwZUwtLrlY2DAWVFvNVmcxF4y6TVHVGdl8AUfRCZDzbsxo5YXTcX
ARfzoI9SJeAF8tAh6pEm7l2eY9wu3mzjGExE39gRKyhzjA/NqT8a5vjhxToF047nyQTxi1HBn8PO
u0dzyvda85WlHwoPVidjfzC5OsKF65AY+O6iZLvba2t1jqHfBh0EPO6uiv0jaSPHgo1HWEEyzSKw
ozuocs/a0HU/pfnGbbq6ziCIANwfsOxXVZ+6hCgLqFbYl1oeWCndOfqDGH4WwHxznAOZ43O2UQD6
o1x8tbZxcqOKhoodDvL3Z4GuoJrdFTUPI/ZSgKZSMj2IW2hXWDqwWWd7+AxRfmJFHv7bnepcT4E5
WEJtv9FhFZk3fvJH7ALVo+kxsbXAFb0HKOeTdNihGI5tXfvZBHYpNbyBH+Ef60vr3obxnTbirgCi
og2LFGIF/ODQJ4lqnuif4vgb5UeanJjxjbifRnqaqlMEqO7tb/vHqnk5diwvHLnoC2ICFusZnigo
Y0ALLxTD10btsjHMNdS/o8nTpx9szL1OP0In/5nQp7yXIK9HeHaNO8MdQKHUYFou4WjuHG//VX+8
Ga/+KvxJBmSEkG4u66fcSkemZxBhYeJxAOdw6D65eLeAwg5ZJnM3TlCm0vclSF/lV9PAnTR2nlV9
IeBXUjrtLPldNBWQtaU/DWfVOoGVM78Z92P7m8sHt7ACXm095FaQw/h7KTJxrNqZqL7Yqi0HbU9K
6gKM0Xm5LHcRlkwlfuf9FBhwQ+vfcljTFfRTWz4W4L4l5k6hMmxEB1PbZ5ZEmd30muwrZbnH+b1O
0gNkuCb7tVQHZYVNcW7ct946TsNX1aYnlv/MKmhQxc6xjE63P8BKWx78dDabkMIXA9WWxVgcZ8rb
qOEWcMC6p6In0txlyf1Yn4FBRzr+1la/rPiEhlxSbdXoV44bFBhQIkUFbn5ULlakC6MSJfKKQczW
erSGDnB756McyldI3gWjLY4DbbKNY3b+zcV6mxHfdHYSpgC3mu9PALs3el1JJNlKNjhsGrv+UCgQ
BnNlbWnyXIXChIIkPBcYcaKiO/A+lGR4IsdVl541867O35jaT1saUFshjPchDFYQpcoqPUf5qE4Q
S0DfqovSsDCcLVjB1XWI0aDgPL8+IStzhaWbRJFLESGU1oug6tuDJqXtQQIOEnbQ7ejElpL3VXI/
B5zpfnjAz2/RxerQ+4pCiLVMzkn8KWJ3evStRg0w3qpmrI0LjH/wjbCVobW9uBJEJgzYJ7rJGaiN
GqZL2b50GhA++h9Ih4+0tX/f3nBrnwySEGDl4tK7pj5UExx6uMuSczOyFq5fyWsjrLA0rL8tamH6
gHzE4xobG5j3xepLwbnV3WlKzilkcWrI2JY/qvbT7bFcbeBFjMXykyKOLMm15IzM+6dliU+Tye6A
fEBvvf1hiOIJUmJbspvrMSHwCRklNMSWZ++ETtVYDFaC8yn2YOvH+jJoza9oXVnq3mm2uqOrn8v8
T7glSp1AugsqB2Zy7kGezZBza6ryxb8sCgs6yvgks4D4Mi9RJBEA3tXpOTWgPjnYZzq656nfKoqt
bSlAanRg2tDEvdrDvTNyHbqd5Tlp7OjFEhP9JKvooLrXmOPIvb04VoMBTg20Fdq91148NBcpnl2Q
IqnroLDQTCzikwt9mpFs0ajXQoFOjxYOAyYafbf3x2BqlWYMk5zy3DU4jfq3sYACw/QDKdjtIa2t
PSCTwKLGmT7DTN/HyWjRJaZJinMFScs9STThk4nuHan/ZIb8gGzgQWutdmMir1582GXwGcc9CdsP
YPwXB2FEZKPZElFb40EnD+7Gw2rr5+fJvXj5w928y+NKlOfK62UA/tXtOVvbQJd//WLOmCwaYkAK
8ex8LSrkwwpe0xtH3dYI5s92MQJJa9BH5hFM0LRp9n9tgrOY/0WG1EurzuoMP99pR/KkG4fbEzT/
5+8yEvy8a+PZBzYqiGhXZFGgOxTEMspzS6ZDkd0NPWhmn2XxkoPRaRwgD74RcGW34MJD1udCIw58
snk6L6arqwcz72Sdn3OtAseuFeTBTuCaDdNiEohRGhsrYDUeLGsgzIxoV6fOUE8Fr7oB8dy9/ICG
9a98izfy5/GymETcdchNGLpVKFcvVhkd9ZgRFeXnjGUS2JlBEr/HnvIBUnLs8rmOyE4WvU9S92Ob
kR28vsM0gemzDxBQXz0bFH3eMtZhQeQa3WsxQdmnc6B66hlKlB/wCfXJg0mWeUKcwWMlRKxLlWkP
pUnjoKyYtivzuPYY/pMTz2H+xJouvheR5P5Q98lzUzHhtcLk9qnjSn6CiBA+c+EzYQVwGj2wCbo1
eJIqL02HFO8a4R4jTZseUHEmJ0DueIDvI0ORZrm+N3vo98DIUEABBtgjz6iyrxCA1EOt0r86Bf9S
xmRs9hAwAfgwTrRdT2xoF9gwaay9zIYlrymd37qp+JtJNMNzBwERYbykXlnZJC9wSJdnTY/cNJAM
+gB8imr4gpujB1MI/Y7pGv/mJoYBejHkCXySxIafWjm9y1Ibnq4N9Md08CP/j7ov6Y5bV6/9K3ed
OU/YN1m5GbCpKvUqybItTbhkNSRAAgQIEiTx69+mz0lilRTVczLK0JZUKIJovmY3l2xevHzqmumy
ZyzCvEz9kbX1wdYHLhG17LU2hF7M4daHAQEMJ1WLC3M8f2HKOVLN+2Dt+mi6oGKAujwW10EUFQwx
Z03gs33lw9vaPDjNBZlONSbw80Pgg1MSlR9sfuAcEAEcpkJ0MmNfDoTvYeueJs056N0A3BwpX38w
Wbj8kYrgjkS2dSjDXjsezNdEz/asPilvo2PyRB99fIC3sDZ10FY/rMZ3S2CUI612H1V3E5wPPeEV
n8/ShyMgGYBYIfT93zVgEiFsYtWc74nMgvFreKzJduTzDxubAgLTrNT4fD8pkgI1nf/V1w8OFlOV
NGVgL/j46Ayo74Hmn3/8esYdnIGgUUFXCJzx1R3s4AxUS1v1dSPavQnHTInxxPOg4LDHUXdiW8ew
Mx9N1a+DHWy8eGoDcLe6dr84UERLPfdIdfCjjbeiGlAfgJ4XcBpvLym/YTNY7ngYKL51jUpH2qXM
ybvN53P2wb6DTBKIHgi+7fhdjq7rwUM5nWFLmAr66fwKYiK7cnaPkK0/HgZwKlCCIQp2+GoQIEqY
OBC2r71xj+JtOk3uTgTLkaf5IJRAOWXN0LEI3mMrK9DlmWdXPdT/ptRNQD+eaOE7F7W5CqFzWOop
Ldsjms0fLIT1FSHGRx1s9YR5+6Koz7HmnK7f19cW40Xfdb+/6eEmD6jOCq+E4eHBSmAR7eOo6+Te
g4uPnwbH6tAfbBsIhIFTBQEjbBrvYFeSLvGaZnDFPnBzdnMzf+3nnB6pOn2wmlfeng1YHapd70Rd
pT86LW1LsU/a5VaLYiEUWFQrhknKkdn6YKWB7ggNSCCmUFM7LOcp1nDKZsn3C4Rx22HXt7sKDcTf
3jWo1AIrjNWMlmF48EpalrT9SDq+b/oXJh5K+IaKb58PsX7EwWH2ZoiDZRU3TovxMYQgj6FHTtpk
G5dJNicAslebsT4Gp/pwPBerDHDHn7aub5dxzUzMXQsXMLR10gH0ZogDpBaDyp6+EvWTRU8+f74P
to2H8gwqC8C3AWRx8HyLv1heiNLCfgmg7w944/I/2DdAEYTIKFCwC96BqqwynkKvlt0+KDeV9TJF
x5opH7yhXz//sPgj/Gbgc9ft/cZL3fmlOabK/dEU+ahMO6vkLDBu61L/NU8ZqNuNtkX3kZdB67D9
baYRNvuakQCoi7wLVgdvPx9hsYOWjqH7JsngRmhZhfxttYaDIQ7Olr4quZ1UM91Pkyzicdo7o4Rm
T7T9fDF9tOkD4IDXwAt1zMO6BIEjnB2hNrFelgksfIYtOyZ/fWyIgy1fj4k7J/WEcqI2Yht3SqEJ
ScsCSqJ2/r97moOtIcuWBrNcmj3e23U01RAWPTH65vNBPjiR0QkDZutnzQgKMG9fvtRxYiAjhDIs
L6i3M5Ab7LPyx+eDfLSCfx3kICITM641WAQ1+yVMno2lIFnnTEfe/UdjRGidrTLQYHAcNjTc2Tg8
cGi7dwOYHGVM//X5//I0/2v10l3/deaqf/83/PupgwEJqQDbfvvPf3944T3h/7b+zX/+zsGvXJCn
vlPd63D4W2/+CB/898D54/D45h8FH8iw7MeXfrl5UWM7/BwAX3H9zf/fH/7j5eenfFnEyz//eOpG
PqyfVuEq+uPvH508//OPNfD+l18//u+fXT4y/FnWtR37QR4P/+LlUQ3//MMKwz8RXqMKhyYSTo6f
5ZPp5eePYudPIFpseKjD6xKMvDUW4l0/1P/8wwn+jHHUQJN0hQuCqofTUnXj+iPL/xN9DjQgkJet
5Ac7Dv/4jy/35vX81+v6Bx/ZdUf4oPAwb45loEtXim3kwWUAplTgdBycakDhi8iqO7YhuDIXb9N7
VT7AUuiXKfl71F9Hebt9fo4Sg/sOZDD2EIo6BxVXAvAmrC4V24A7uIEDzfk0R1unni9bfczQ4N1Q
uLqAEIJsx5rb4Cp7u1NL5YG10QRkE8Vo2NdWmrRFZdNd1x+rIr3dSniog5EOzoRwsolvkC5ttHcz
+bftfPf5pP0s4/9XULMOgAAZbwCa+Kgh4w29fZR4pBA36UFi8ztay2+L0qELC9xu6r7FjcXkJbq0
XbAJAMGQr0zEc3gbAtkmThrVqvkrYLcyjNLIdIs6E8wa9A4UtAhOvcvg668MrH2v8DWkTY6UiN+t
KdCOwhgQO7BOwAg5rLIY8HakNTO6Ecld215ZkB1pmi9HJmddmAeTg/0EFhCqEz442gfHPogWsjSm
JJvFIs9uuOy4MVAtb9IFJqS94TkvddpPTm6bI3fB+8cDKX19NoCLEsiqHIwMbVatpnasoZCm7e7c
DuL+ZqiIGs5GxA3558/5fpFht6BU+ZMYCgP1g+XcWW1Zu2FDN6Qb5zZfWndsUhRTyFx8PtD7p0pW
tDn86cBuQVxw8FSTQlEQYQcGqvynkEGRT6MsnI3GHNMTfbdDwaFejTFQkVk1dQ6tD4IktngsFquo
pLVNWAjMyCknTebxY2fB4eQhhQKOz10LvZBIRS357QZyQmJgZjmRDWqtRU8yE1i/+XpAMkK0uQIF
AfFBOeXgyq7cyJMRwKtFBVBxWgdQRvWH4760f9Wqfl3uiNawsGAlsjoQrOztt48SNZqoFkTTvCyr
9tKreOTWV6EC5zYmuWQo06Ur+wYiKcLHNwmayqh8DuBwCBQRnb60pkLE3bLetjdNYEO/AXZxSmd9
4lUwr4um8HVYhHeFa8I5CXg72NtKK+eHV3dRXdhLZV/T0BNdXkcVi/MlriEaD9Vj0MihzF+lvnTR
E2g7v6uyYXRjqPSjeAF3c8DTvoR9DVYlEnNnBxH+qT2TxkqgLDyMwVyE40IZbAlHVcLTjNjmLEJV
ws15TSvgY1roMHyl0ivDjDVeMt96YWWcBKXlehwy6tUgOMYtmNNZwNi8on0avYfClePmhkp63TYh
cGkORAPh8UmmL3Gz4IsK0CEgIz37+Iqz7ttHOVbwNYEecT9lTVmqm3CsggtZ2oMq2oj5UaZF5Og8
hOCJs8Vk1iyFxjDgaCMD+xZvjwuI5WsH7WVLA+cT2EI/e6AKA/VgT9FlKOC5V+jJpxRoPRLutaDI
Gw01NgO/2NFtWhvdXXJ8KZGtMcO3Uno98JN15aEYA742SUk/iGlD4Gur8NuAOGfOEBAs7IhMHOyw
qTlHLyK4jkU88axeBrPyCzxwtwffRabqM8nFKQiHGG0yVTXAqc8WXgYWJ3fSMJnEg/QWRtwdHFDs
Pq3sNnp1g1qBsmao3aVjNA52BjBMB7fqhJopY45vQeiE9laFbWaV140ZSvhvRbDkQx4egTROt/0k
5CN1UTlLucMGUkRWsshscT2RAE+2zBcAL8cqn2QCPbcx1lBohmRLFxUKhs9WnsAW5r5uDLdSOsOD
MKeJx26jmMLwq/LGbi5q0UCC0rUtv80Fn4Ylo4RDzc9lrL+rhCYidf3RM+d68alKp7EUZBcBGBsX
wYSuQFFzrMBUSjC4AWVytwvjU5zGCh3rFM2KUWRTwiv4cQ3G+xY5nH91fNY+uzELHiOoFYq8G0bm
ZUPQoS0URVa3mzzi3GJPm2DXhx51Csh/sse15dRnFi7Jp5EkIEhVKtKvWFtG5oaXgBaaLllIypph
0qlyla3QcIHy5MnA/bjdVGgpQ2R6bhOWjlhOC7BPysF8Tba8T4JuXntzIrEAA49VfCfdANtLDgGD
r6NobL5zoQk6ZNMId5rUXsouzmtXJ2eiLZcq1aG2x2zhojcXHqyhrigwMHFqT0M7bytr7uuTucLt
n/LAs58UZaQqoAZg3dreABimqolt5W4XBeh6GVq2aWLq2MtkKFudDQlt2y3xaCMgyb00bmot2iEF
pbF937id62Je5ujOnYi+FwEVECC3/NXegjU6Y5XXbrnVjpdxtIBTqTD15wEL6Ajs3DDcjZ6rb0An
0g7mMUTHTTJ7Vlvp0+FMQUsSlDTAS1/ceZRTNkUquqQC8UvuWYkawVOW83xbz6NVQei0hF/Tiazd
mGQU1bfXBvezXbig1ZQ51ltf5tJN9JI72mF9AdWExc07AIudtCclUCVL3/k0T+xRwlWCoUs7uPNt
wB1r7yo9sRyydZZb6M4KXiqL+8mJaPy638XJADZ9VSkCOwVcOLyA1Vg75yEnyk/BU3DtVEjjXLqK
iDpLeMJ1OnM1QcnDk7xO62EWKnXsiAc5ECJY6SjslP2m6nppirgTrNpCsqty8wEO2UGm1i5o2tcw
DC78WtDxJIIgzFZVcB7JB5e0S+bVCXnoDUmaIgHal11WUcNuW+yoJq0nCQ+0eOrHCa16OeAw7Rjp
s1jDHSUDHxeWjLTq1CM4c35QzAwOT2fQz+jcHfhtkDOoRR2/TKD7YatRBfVSSiU8FmI4X4JX64GT
sdHg2X5LlEiczFoSCbmHRojztheuk40sbjFy3LY9/H9gZ3Qx6RJqDHJ2RH05VrGjM5+N2srH2AMT
Cu4AROHRXf97xUc3yLxpJK+SWnVYYKeXcTpCS6g58bmOq5zGPY529Nqgn71UMTxuFm2rF7HI2aSw
hOqsNAAR8bqtKfw4pxIikSnswFZdVoQdz2MMidYMQZfusxp8rDgP6yp2UfyKcbRyMla49tAGNdjM
0YjzabGtOu0U2qkZUj/ZZYolELCPKCDHtefMOl3KihKYUgSuSHXrRmc4UDQWhmADcNAWyqDw3sEt
kej7avTmrqAsXnARBHQYc1HKsMlU15PvcMfBwVNOVfdcjqbiuNaYcE5rNFFM5kpqR7vVtQoKwVPr
77sRkB+T6AEu3YhUn2nCxzNIJMEtxaJYUSlSMbDKmMOmKx0LVmfCnbxnIxrUfiaE0jKj5ZLo3CE9
7HtmNpIvUtuSQjIO5dU89iAbkwLo5j+ygEcvS5SUM4auxwjhTDV7aaJ7BBBRPS/bTq7/PY1B9yOJ
TBymwl7DEuUstpN6wwT20BLCuiOr0d51irbD1t1Bvx7vOEMJ1bofIsCMUqGcxtvUieAPVheN8Jsh
0EHJsOLo9wFEb53aIUR6M3/u6YOeO5w/UkKiJcWTiBfIHghMxmQPBva6fjdnUkvjFzAWsV9D7ULH
KZr83s0U8roq820z3PfMAyXHstBzgTqYO35tXUPmjMWe8fOAOv0tjJqVUwA5rW/LeUzsovT92WSh
wTkXITl69Em5bo5IwdwV2ASyPFN7tmE7bNkCeIEkbrm47OGGEW9x+3ZqMxKXPPYzcwz4AP14MvZ0
DDIcrMG3tvHJiJL/UF/IgS1JFvWJuQGMloOaMTkh1JTq6QkOUW6fBQ2cfrOBBuVNBz8SrG9Y534h
YbDkNtRiyIY4TTBsfEW4uzMlMAgmrQnS13OZ1OODlpiQPR/t6NUgdakL5YUMvkHTwMat0tpxYDc8
eWprcFZ4RTd5kDeWEvGg29sBy0QdEFPYyH/ukiEWZutZVfC9GQc4BNmdgjBI14dlkEIUFsx4rzLx
kvoqmq9b7cfwQGK+fKoWZYZcWLNo82D23FdZLxXWYt8lEMOeyqBPgVDV56MT0AQYfhacBmha4oiT
XjKctRj4DItdk9wJKYy/UNZMvM1UNUNSBK1HX8tY9OGmHnlZdGQQy6b1EQzZukQQszgL/AY9IC6u
yUKB3tuV4AbK1wFm7csdEnNvgSigw+xTblPryTBngIQ+VDT1lBuE/dNWsMXXWHyE6PCyY3UzXWhu
x+LSY1XZAMk+hsMO6t7utG3CSQMuLsvpe01QWihUDGRxCttvvmxlH3tDTgFL8zPaShtBwgTV8qwh
TUT2sdUjYFxabtsomzhLklJWNiyHc3n9FFU6fplng+sIkmS1s7Uka/yvQwT/qAwgEfvexzetTrjD
jX3hSWWcU5QhiA9h66RqraxxFbTB86ZCoepMJUZ0MJTGTX1ukPYiGm8p00kRaWL5YU6dYPWlc+Iy
ToomJMsPjYqyB/W80TwMfeV/BeLeE9sG2Y1OHdJIC1YKOGR3yTCVfYZTOwCJt3Nwxc85KKGodzbE
AgHWhlLD8G0IdL1kLvFLqEpGde98b+IxpmnYgra3dYVh1ZXWcJfdWb7BQY3wHkro/RiEZhPMRE+n
cEPDMe4scTid+kr2fAt2SoVzxy8BhAnHMvkyxKMh33nFl+8WJLOSbTnxyJzO3LKfkoUSCT6WPU27
sNR+lak26LVKoaY8BVtqKpucACjk1JuRGQce4sO8OHvk5Dq6dEGjTgqNDtSc2UPvg+IX66rNI946
/g2Fh3UHLkrJIpYmzFcvbtXwedv3CHFOObCb7Sl1jENycJRG/8pvZgbkGIXx3W0ULtT+pk2v/Bwa
MgGUliBm3wQnMeLC8B5aFggMzIQeVVoiBB0u4GOIg3cYPdU/JgB6u3DusIEhbkJA9Tety/3qum+X
GmZeIdQ2i5baTZwmYzs3hT3xUubUuBC8sFkDFT9uhQq7xlOwQQYNoVeYyBngkLgVvMx6uiy6wBES
k/txLFuW8aEDmxrCzxO7mHH1j1cJcyykMswClwOm3NEtt3tzo5Mxvp5H5XVbFtr9U8AiM54G2mva
fUe96Zu9oFMBJ4RkSHaLYoNzMUKUzy5kNBtcc9DTnO7daYEzUKPdbio4GyWkoP3ScW6GhvAH1rnE
2broOr7CGE608BRHUnSpbLykPMKLtE8jtPLDzdT3lXOlo74xJ5r1HUJpO1ZNlJLEgoZIPtuxRGho
JWD+MLwZnce1jfuQRo3/7HmNJU+lgFJWBRXGSUxnnbGIBSKrLxD+2Rp3a7XM/QAwdT+0qWcpLLMB
DndV4UxxHYBRRJzqTNHazGlLUArK/JEQUCpLAMoQ19ilA4YeMWwsT0H2jf2vnW/jPmxFqX/4ZYjI
g3gx9KoW4uVEhvrOC3o53gZCNOghQzX9RZRIkzcmkerJhRc7Em2+mFN4vFjN1oMSyG0nQEPIfFpX
L4PtA+blQ5fce2aqA8Ssnyj7vsi6JrkxRFwkxMCTPuiaiKZNPyE98VEzeI6XYaZQ+ufk1VVGWnCQ
EEH33e1sqHMFcRXxs4711r2FACo5mWXHRRoYgY4HAfw3POPjXGEvO2Nz5/MhibMGZI/+GkIM9V0b
tFV36jQwUzjhbKAWrHB1/E1yI79pUQ56g7xUlukQ2LLM49gnDVRWLRcMLdufgebTE6LNMBSy2q1n
E7sadIiL1e2hY56xXiN1AENxPm8ZDo60pm3gZS2uFDwbeN0RIvvOuasZzgJYZJDmFthhXPB1E6jh
wnfmkN/OauDk2k567p6CAT+oc20hA+lTL5RJdS4sv/sRwDUWJZRB6LBgHHlCXjEBUPrgRuAKdm5Y
7xmShCHlUYfav0/A5s1QmmM000G/djjlFEvUefSCG6WTvnvR8BoQHlIhQ31CUNZgt8gYjaReCz2c
L07Ar8e2jmEeWTUh0jeAi3z47C49f1J9FV6HocvKLR3mWCLicJ1XFFsW+LnGaui3fkzBUQWfHU1C
M6IVDlF8GBDiDPA4nCcdPOEOl7C7ZJbmMKuovVJauwFxZp22IYKUtFomTfM4AqE0DZFuXkNcsTfn
qNba6Alri4X1fVRX4stSwx96B7AkMqoFWxUSPUtgq9MIogETMOcCVL3WBecCGq4YKo1F1c7Z7JZC
5hGtpg6IzSB5UEOMknNvIZiADP3ofZ1qau7D1nW/T7qFcF4cUQcoFHvBBrPglTHtQIupSAbRKtNe
LzP3sQM8BZpoYIAZbP06NKnfAM+ZYdKXNocunGvSFkUK+6RC6uSl8yDjJ8BQsH8ryaoLl0BkKVUl
d5ZilO5Ad4tu4OveW9EDoJjlTUhL0Mb82mrmvESJd2tqaxKpPzbYeY3XxHGKBEbxbY+E/RRg9nk4
Vc1QXxMtQeANNIeHZJUIK69DjheEzAI5ssBc+ylrFWp482j6L0Q3HQIvyaEFbYdKPVRcBbcIW8xt
yRqDL+7MscogowN/5xg+54/CF/MPr2FBn9coTEKpmBF14sjWbzPjYBMVTtnJO3So7HuvxLsrlBtA
hU/oWeKXIwsfRBY9hGhbYYLO475VUzpDNq9P3Xhxrr0IJMbcohL3oVqkuJ1kF+97QFyuZo6SbdpD
k+l7snj2jPU9c5n3qlYKPJsyuhYe5XM6Q0DippdRRPOutpZn3obgFfGpCi+a0UaIHwUGdbyIh+El
acsh2OqQ1dZGUVh6gLWHDlGWhH1/PQUat/gMEWiQDWbrlVQMCVQM9Xer6OLFdXPo6kCS02nsGFXV
mI+AXfZ2HBTQl+FI6mtUBRCqVCjHKAgOzxmSp2Q6xfYxC14SZKYzxf2IZKgw+efBqKB80ditAIG0
XwQM6eCRunLzE0gYWrKi8dZFvICQJ0xqNJTq6cFhngP/ktXvDtKFsDJRvevfdmUYPYw6jOCiR328
XEQ88jWqLBx6lIMPmDO3RKXBHYbqhWpfPSW97EXBxpq8hl63oDTtTOxuEMl8L2ubXSWyncXGmoLh
anY5jA5wPyk0lT3rHn4BMCttOrq0qFCHwb6DGsBdIOACiAOARSOEYkYj0iGxRhwP4RTA87Sd6uUs
LJfu+4Ayq50Tp7VPSVNKkum2RJTmlmX8JCdfo4RKiDkLpUR3MCEiOW0hBmGlMK9FrDRws/gFLmzE
HcYbk+8oz6FcGyeqfQiVT9aElTszIpM+TjK/GRsnA4qye1JLw5cMUZeDk2Iu5ZKSAPUtyCyF0sG7
XLRIo1nzH+3UJSeJ72uahTGO68wDfLsszArzXIjNeuzuDkFyj/Sa5BoCEjC9Hb2xziYH5+pp0ml2
60YoWow0xIUv7Tr6Qit/+jKOLlvSvqJBMSKqdPLZANuHjJglsOXsWv1c13GZWxKQa443/Ag5fRQA
EePRW4eVbtF60j8N+6raSI/XI7xXLW9Kqw7Ol2lbhtO3CMEclKMmSq9YHCf3A8oOr6Kc1M51LW8s
UE6GQCpUI6xsTSgLF+qgIdRTMy8R01WHNOyLqXV7heIaFMaChcOsvG71g+ujULSJcEuemmqOngOb
tFGB5qrXnflU4JAxHTVfoLBpn1U8di4swJKHzLJa82zVMTYR6rLqe2Xm8b4bpxgVMYsuQJzPEGp1
+wgtEOIH9Bw5fIu2MMrKwMF77RRnFAjIRwftRWzayJtfoToIjjP8Jue7GWx+P21sBBOZbezkhz9o
bDzsu15kEDCaTW6E6h58i7Qmc6bSgwQiYhYHB+AU3XojMlfcamK8YFZtONYoggmwwaKwRSgd+z0q
TZ08aWfFEUnrnj3Htoy+QpQiWdJRL+wLsRW/cwcUMXLHnyFvGy1ztCD4oq7O5lIxqHz6g40eSEPK
y2HpVZD6gnjQeWh58pDUNY9QEipRxPCMI2+8qBY/KsRPIkWRY61NWJS/GK+f7yJwGb8H08yxM/36
BcVJHHEAHyddrhO/P6e24U8M3TQOqzpWzqnPHQ8If01lkUhO7mitRjuzOxfyiBVF8ktMOXRYfOjF
55Udt84miCzdpX04RVHK48kThZCgnaMOhhgBXsO+/7xU7mCySCTs2aDGgb06RcbNGgHmIAyfag57
6b72sJXKRj0BpDO7+H66u4hawGrAamhwRZnGVGNqXId0G1mSloJ4hckpqJ9wRDjwuEohx+Jiz4Wu
vp6gsqXyZnAc7P6eJfuoS9idsYX0U2yiEuav/cBTMNHbEb2sKEF+BjGMq8Xjwb3vrkEZrrMRbtXU
mYJ0AmJDuXM61ei/d7MVD9C36n25NsbgMS3Hdc96Pgp4heOMpSkmF75RYLFPxE47FA/wzCUJWN5i
EoeUgHizZEmjXC/1ADUP8zlcVliQFjXkNZhdjrvBlK7KYh/pyAVO//AYe/2whwomDqDB4BgCtxFC
X++gwzlGorZpItrCMu1SRCjc7OaQfP28+fxuEAi7AOMAprAD4hpglW+7m1YTgpO1ALC9WKaCIJOs
z5qYDLvfHWV1IAHYZYXw4U0cwOsozjPg4Zq2cKUlLmjklDcVa7vfQljBbhF8FhwLQNMCrQnQJqA7
v+IQk3ZSeoCPLVyrlJNOAg1FGaNh8JvPglGgtwL/HgeYIhCs346CJoBGksdZMZdoNSFsQb89cwfo
dP4WePevx4FeNCgC7k/N1fXV/QKrHKYkqUq3x+PoDqL/rlxd0mHojtV3DDT4bhXgmaDMBEw16Nur
eu3boXTbokhlYeZqN5Dw5LbFZcsrc+SB3o8CaDha6M7qVw39pQOgg4RQs5OMQ1uYTsKdL4mjSz+y
rM3n72fdFr/266GuDQrbys0FHBXFrwPchohKh3ALPqZYiAbqHirZ2VOvL1BFik5i5AcF+FDT7y7w
ddCfInYrPAUo9bcTGEH510WYTAvh9SjuLBSZB7A6vwnm+vlowPfgLwFbAxDt7SgjmvHAkfgUKDzb
KhrXEjsoGdOdbylvJ4C/OrLUD6dyVSuHKDNU+YCHc8C6fzveIgwcsaCtk7P1Wpp9H0acIfIv5H3o
PFhXvG6Puc4cgmEwJGB5eLoYtwiA8QePSInbAsI6B3nXkXLXWQzNh0EFuWeD9/f5Qnk/FBYjcF4w
NYLwIIj+b5/OUmYJw3kMcstNeOZLAUxGhbb2rNtjL+5w5YPoAZUmHLCQIwHC5HAo3D3hMuBxc6us
UTSte4gC9tJBjvv5I300jg9cIhYKFiRkGd4+Urt4XZWUxM+byfNgM4qosJsj98hi/wl/+3WLYQHi
IIfEIXwZIIF3CCoMlOK0cxOy8dIHmYpzL7WzKdN5lyWF2VZfkm2fHRMiO9A/+YnJC1eVKwAZQSHE
Fnj7bHbvhB34DHTTFWYjcniQ5M1pnIuz4BSQlbvPJ9Jdb6TDRwQVHreJB58d/1CXNxS0Br7OIxtZ
BE9zTm6qnclv0JPMyQlijnzKgXxIX/tUpLf7z8f+yYJ/PzYwR3C7BFb4EObmU2e0R+qSzZR1KWLQ
3VpHTE1a5tFNVZA7mQMNsUaIqcmGi7IASsNLaUbSaqN2cRZd8wto+O3VrtocQ14eGNr+9RZgDvMf
3+0QteolyAMGhXlBiovGj/oa7UihT8VXecJOgr3azKd1cexteB9BDqHf6To+YhSg8g7WdYT6KAUn
kmxYWu28DSQEN/Gpm027uGgure/Wd3I2XJXwNkBt5bq88jfumXVi59N596W77k/9HSL7I2fxz730
5i2tYDqIU0GdETBexBtv12PtMFUOcA8twHi4Hq6Hq3HLTtV+vFgu1nXpfg9OeSGvzN2wp6f8wf5x
zFvpwPsI7yICHA08VIRWq3b0IQROAOBioU0MwvSJWwwnZuPlSBBSd7NspnOWi+z584W5nr2/PjFA
fR4UqhEgrFrPgN8dPPFYuyiNLAB+Zl0WX7e7Y4q47+8bqGom/uo0B/QgQMRvBxCLAhoK3yFHu9m7
QbgfIam3XLaBeFzzMLYcPXJvnI9JKr4/NT0QMvBUEJgGJvvnPP8SaNE2dsppQdeCh53YoHbvnMgA
Dhufz95Ho8AqB6Bc8IZxeB7MHqFIQSLT+Hkd9/o0IKAmIy6Zfos6HABvidW4BligMK5ysAeRdjA3
tQujMz/XCGFR57V11tJ+PhJpH64EjAJwLFwoALBfZf4O1j4ZUFIbB+HlYW8gE2FKZ0PgyJGiXRnk
zCby+rfnbtVbAVbeD6GUfnj2B5MMJvS/vNxpnXHTW4m+ibp5fvl8lPfLD+IO61ZOAABH6rW+wV/W
gekUQwECo6Ck6F4RqO5vx0CqLyWPrGvTAHdQxzGKBp+P+j4MWU80xCARblNEjgdzmYwmqXRbewiy
IF2QVOjXlf5AUq7F3567v0UR+W/5H284I1dw3BvG/uUfF49C/WMz8ufHAeSM/wOckZXj+N9zRk76
l/aR49z7i3+ykkzWP/ibMhL8ia48eB9geAQrS3aVsv+bMuLYfyIHx94FLX+VW07wV39TRoLgTyTQ
4ArjEAHVEZLD/0kZCZw/gRzHQQaIATLs9Ue/wRg52HVY+ohSEUf64I2EII3gK/y6Pp0qUkrBcS6T
rnuPAMlsEtG5BTXM2gK9w/JfZub6r4P9V+rIIQvi53j45pBgRLKBgPLgxGpcGJHzGuMp3lQV8GwG
iBC3cjc6+X/Unddu3Eibhm9o+YM5nDY7qNXKsmzLJ4TlwFAki8Vivvp96DlYq2VYmAX2YAeY5ESy
4hfeYNf7zh+6Q5RYcgPXhjZC5nufC2+t3nQuvmm6ni+7cXqYvEZc5mVvbSkbi11REjv+ux20vie6
D0yZx6FnsXdfj0sUgbyti7KJ86D9ouSYXWaOiuJ8VuodKuXbGcBo/pfKBIosmF2cPcnqtWUuumnj
IcrUYZwm/2AXYbAbilB+Cabovbzh7ETiy/i0gIWDNBjlBvdsxkmG8qqljxbbtEjjeYUtZ6LOQQaK
+bof63aTO0b4zrz/4SNJZXnamvtx0Z/dwvCfK126YAlrh4KyUVYNmC0htm0/qwtHGj//vszOA6lf
H8kSIYDhxoIqcHbsdnQnnZJWbewudYZUGJXCpwyMWI2ZQa0/FyRWNBl7y3h0gsaKtsnS+o+qDL3v
gSnLaENFk5wqnVsLPBGIpWCXGX1TIHSSL7TdCtf/UFqD8w1dTfOLyr0aYIW9hI9FJa33ROr+NHYs
EIwTUe6mHLke9r9dIW2uMJHOGhVPgxle1VCIDpWelqsqFXIH7vE9IVjsn/gTfwvK1tGjBsVxwD3M
8XR+FS9ojzuqbIAXGoG+BKUoKZoqu7/Lc7PJMDdBswZ2br863U7p0XdK5/Pgy+gkFU3NjelWTnHj
zuHggZ0sKIMC3CITtg0/vzSK1J93eeAzLSqq5x9OpbzPqgczcEzdNLvOdJWuLuC2qw8N7l6XQqeF
s2tnq/7Yt3Y3QswIs+nAvRmWcQoL5hprSal3Qd3Zl9RK0vsiiYBX6cDPycHDLCw30qZPsQlnWTzQ
3WxuGz2YX1U4u8ybVbbojEZtvrYfdfTQLV5NM6oD5bCzZQd2ZTAnO6RW0amPEcS8dicbQUfZkvmw
BzkMUtpvGzz4gEgr78LtG+Nbkk/eR840WpUsNvW5bBZ9J3rtyVgFeXARKNO9B4SPRsMw4lCsyQy8
q3yqymcpu8behLmpXvBbDJ/cFmjktqJnuyUDn0AvBEnnUmb2pn47jon5bXSU/UwZzyjvlJ05wTab
9YTOhBQzSkj1pO0NtrjooqVVnoMr8WlnxLQt2AOt5VnjTqoC7zZQtkpu6mbMrgMYKU9t1dCiMIBH
zRsJgizHG8cR826eR6Q5Zwxprw27mObNMogswG4iDfOLfmiMYJt7ApIO+oAF8HUd9E+j3XB8ZlMG
trYH3vKsRzMEoN6YM4gy3QzeDkZc+6UCIqXjHJQxB/wUFTv0sWSyXwjkIKHYls7iJVPNTVOH2ExU
dl3QrVUjGrVpvbjuXjtdN+4LkqgcBGWQUh5uHC/bGtCHqlixnz+O+SrnFxYFtXofkEayqUbp8N+u
WX9CZmYZadgBNaHv0tMen/Ar3iCaBTsionB1Bcyx7zehWUyfwH+4USzDSPUbZzbH53EABLppcTH5
GjReAIy47tRd5iH32GyirgkX6BBLmu1dVy03c2ZGKGl3GcctQWJ5yFAy62KV9HKIh06CI8CRObnw
Z6pK+74YtY4bTwUdkrfauiMmT/OdGDogjkkCZgHAUz4iUVSKn8MCWCV24KF8Kn1vvPMXs684QBbc
eItZpDd2WfciBrUSjvs0kVA5vE6Vt01lO0/myGG3m0O7OWJwVkHKABa2qYYxGjACnxCKG7vAfxnr
ob4J2xBUdd/UFCYzrjF7k7Y9PfcZw4rvwdCv4aePtfsWXPLyaI0ydDd0kPx0F5bZrCAggeXf6FBN
xz5dVMQenbx6lxchSlspBZOfDH+Tx13XAK1e5tH6OeMdjteyMxjdruvLOdouwdLKHbE82jcUHY1T
1sHg2Y5uktKOqc1liass96KNPazqXABQ3Svfw3FhM/R1r7dAFKeSNmfpqrhPTYMe+Nyh71d7xog6
rAFeY6NBgb4UABMcACIqv+toB0HE6fVIZ0dXJjChUPqfbWMQ7aYQZQtnUdrjLiiVcmOwF9H33up5
2STLjQ91J+b7amwC8zAA9qUh3FQXjWkmD+vedg9IMivU/vUwPBtuE33SCxtqY0F2tgDGGukQ1yCz
y83cVNEPusvZwlVqjieg8h7IIgAILgLxCp4MYjOEWDpN5WPe9fTL8l4CdXdmW1+JksYtMZRZ+pvZ
b3348KREMbYKQsdgJyQdy0VU9M5M77vXLR1YTVvKwzhorzsmbO+tlZqZF3fOEK0K0eDnaWDK/gGK
Q93EKRoR/R4MT21vyjAY0ngcJ3M4ZuBZb0Esu5oDoIAK4AWZuZrlrke1BYb1kAUJSKGpTJ1PwLjC
D80Md+sAL6P/Ei2BKo9gw5UAA2e4n1cCgg+aCuAJ+iAWbc0069U1bcKAjGfR4kcWZNE1u7L5kg2z
/EbDUI9bT0sbHTcrGMstgqlYag+jMZ+4HLNbQHslgEa/bu0Nx7P3Ha5hSzXMaOwvPSaVaYw9NGya
Tjn9ZqhTUPngFM1rqw9LSrEEO2I/+J524mB2sepmOsf6YeyEZ20TatTdlv75PLOoUvt7AQdw2bSs
Gyh+VfCk6YV/WbLAXLYQ34DzTiX0nktJrtAB8c6AY3ZVMX4GqCVw4QwW73ZBUc7h5A4qeZEMOUgA
RMeHMuZHtck1205XMKrGKraaxPuG/EFR7pKZzbARyk/sbd7YQxiP4UQcUw1VSlOjkkCswNnDQJjM
2Tgq3DRphUKW8DfKko6E7WHY2SYplvqq8Edt7kgmVovNYEUzghNCXFyr2jAOtivFrRJTMm8VHAxI
3HOSPM1EqXiU1kqCyaCD/4kLrOMUHj2ayQSMGQLUyfLii1pDWSz9+bHqTcVoVC1X+WwNTbpffAkb
TknThTHVlVHLz/qQ2YZKKCcWXeWr7VwH+bFKNEisoBLBC3Ay0nHDGmk4JO7IEW9l7bJsmFv7CpgM
CHldrp9ABNl+VK6S2RYIA8CEPEsmytGwnJ7ZgV246bRcPjv+0rCf3BLQszsHzs9qSCqAUXDYDKLN
haMVykn9bPq2sTrGy/CbRUaOJ+UYNF8GREEqDsfZfXAXPgFbcae4Is5q4Uwkg/UtULCcfKOmgmAS
TG1MPSQ/AW/TvhMMldhTLqEeSX0b4Xr4/952rERylYe9891Zxm5X1ov8UvWzd5tkUwSDUDgtPErD
vgZhWLRce+VzgK7hHYDOrI69POnUJp/MbhcNNZarRcslYzrZXgSpPOYS/vcKpKEP6tQDvEFp9D9k
ky/PHl7iHwDqjic7UDn8NFu31G2DXj+PGgh+rDIoE1XieP6169SuvigWb/w0LlbRxAyceb32FebY
KsL+00DA9BXahLaOmVrEh0TWNueqzXUTjya9a8TjO3WlvKD47HqJhGSpar0HNQAZsqtFSeV6IOZF
pDBnY5mi7C/bJmjSWPZE6luYZaKMuYDnn0lfVQRIltNYK+2pWlBnG6xHiPYJbu/VvHxS0qcrqycP
PySpIn/TiglPt54lBKi+m6L2YXLHGpQ2/IAPamwGylaT9r0VjO5JkFdWqtG/rJNu2pJBJF9722m/
61GLD8gOguGgBAUJyEQv9anKoqi4SHTrfWbRBh+yZmwuuedSqKdVMBlbcHdVvSU0VNHWhZ8UYEgr
c4CMY4iKu2mrLsN6tmmSXWGVqYebe5lnl2YZyqPS5pQfDHrn+cambfnZmAMuRPDV0EbhQIFbnhs7
u7Iz02k3gSfsF4Samh4OWptHuzyqihcVTvTOwnZ2iKd8zyJFrlR+cmcT3mVbltEDPDk/unA1Tthw
OD392CX8xjhCQubJWrziogeCCm7OLarnWXr2gwsA6XtTmfMHK+jmZTVGBMJXm7kgFKPAOZOImMlz
Ug4rPcrsSrVxSsNOL/JorO91Ls18C603yrmpMudWZRpGDUy5AkrkmHK+A6cfn/La7+VmymZitq5Y
Ad82gYCCbhgZd22REq75yq6Pg0w5khzDEN9dYRL8LXCpkbpLbGjWlk1jom1mcxP0A6gzIoI8OkxB
sYZs1ZjggEx5P9rWUbPcFUbSolqug+Y70mBc19KykzxOctqEmyYdrGMIpurCl6U+TAILapebRMSD
NfsX8E8tZqbvhzuQT0TqyaAb0tdJu2Jr2nrGh2gcBli3aWTcu57l0MxZsrHiJlmsHy7h4g+I020A
O9pGbNxNFTWGqUqqGgDVKDDYHiWmOAh0TvByOyQIfIh3UIN71eO9HMxObA4mYwrcU/1QQLC3g9tb
9OYKqLugcqscqGOF9ureH3oMtdM6oaLjgZ1r484W4JXmNpFfB4KhBJMpgcFx5HAyx3VrjW1ctllw
XSgNcSsYpolzwM+9TRuYE4Bgq50gxy9QcaAJmuY9XCm0soJcSSdewp5yTzl3s7sdlequA2deoHxG
Ldeo0APkSe57InR+NSxLb0w2ieEMP1BbhV2eVp5VExlXTCHqtO3FJMe2BLHqJDm4SzqFK2t2+lCE
1QgEVaJvNRH3H4XVAAEc8Cs9qnpgwSUw+x76YRovIypInwbLXJ2g2JoQ3Do1fUlspP7sGiDYflHE
g5RaGnuvPdW1JHNc1TtQ3dM9gI8A6Lkvgg+0jg3gbhIdkDiU/ZLsLApPOvYqzpzYIC6QMXSy6cGd
a062Bd7YXSoX70dndYT4ij7wpnWq6mfkdPqbgJ443RR6aZ49QHDEgyCdMaFI8q6NpZJNdY+Gi/O5
b+c8AHKUwTtB5K+rYxiHFgGViS4GBkBmL3YZdy4ANacw1RZC7PIJfLc7nex2onKni8m5scraK2PT
KTiJy8BQF0s7k9lNLHtam2XgJlBexAy3JK+q/Ri2aJ1H01JMG2Oa24/GDAF3y+Rbt2VrzSKGZjls
y14Xy7YxtXeJno7vxnYBz2ezAHq9inQqrW0m/ZGoMuRA3oyWrD8IL8Pxr+om8U2VVnQ9FXV31TUS
yoNS7erxWjTl8xi00z1S/MaPIlRwMGfDS8Tl6kQOGbGCEoJp9NRfQxVi/Y9JMVo74qTI3mgRYgBO
AgrcVgX6OQJzqy/Q9cyPnYOnRAT6eD6shFd/C1Mrx62usSgvIJyRvsBYN5kwWde0NzKsYiaF1gGg
VmsUuyBBddhWlhGQNgMrBpDa1Rj/DCJ19tyIUJupChvFvkPF5CLDsBzQhOeKrwu72ANq1VdXpZEy
2lk25De2O7g/i3Z2f+jcbk9hHgTDBcEb2dw0RvlHbCK9J7tOOS/8pEoSaHl1cQtZbIliJq7UcQ0D
+dhSwfcRcvDdny4M1GXr6IYdgWKCdOiMjq5xAPnpTlvaYDYNIt2al9QsQAK2Ml2ARUKo9ijmFPNR
qkm4pJJ4Du6BGoJ4lrkuygO3LN6J3SgAFGZLmNN+DVrjNLk5mENSo4JzCJ5cA/qRq5NwrvnW2Vmh
tiA/xxsA78uXCajqlc5n44uaKuNLaVLthuspbW74GWGcyxQ7GSIEblGQpoC41KUo+hkpwXJuvrZ1
lwTrWTDbAPllWsY9NNjwxrVq8xHXzmDeDeEI1I+6qfkdroMLuhDSrMD1Ejx+qTUqGXB9QDOL1iqe
vG50P2s29HSsOuX+mPNxeVAgstI4ghEA7FGnfsNCtDy8Vb0kpC6jyEYQuZuNk+BA5oeFDJ8c6JLR
IUfWV24d2XO8ZOwIBGMsHhaPLsSA4+gM4VVUi5wRH7Ls6LS2b8WumynC07p3XgK/AIdsS1fXRyRF
vGEbNG0BI2AVQahbmehNLUvsjVUymcEW7owV7QPYuxBRi6I79GXkVzH45L7atpWpbqgrZwaF0Gr2
Dqpb9Mck0C2mUXAEY1M0WUJlyK/dfaWo3MR1Zbff85mgEwakh3NeNZn9KrhqZFs/FeIzqnZkqfnY
Rc5xRbNz30jbpCzSN0JdZoUmrNy4LbnmxtOWh8wEF8+45WfD7nYspPeSW+3ArdQh3LI1wVh+skHY
R7QwXIzL/SopwT2nswFcFSV6cbAoAP4c5yK8Wgjz9YYtXr1w3U1X2oKUsF1LlRnBx4g+eK2KxNta
/APVKQx7ti547mjDEZUEce67yZ1qS6KcFC0IdUldpTiRXMzw9HuSy1hp11+ujByGXQyxoSo3Ymh0
FyPokBPqT0NkiceJb6v3CILCEx8CDYnB8UmU4Je6ceoM2bjzZ3t44S7uuz09++waCl3qHStZBPWx
kKVHNBT40ttlsOBFXPhlelvKYvr8Xx5y4WbdGUwu1cW7Blbzwxim3c1/1YmYF78aKZCXtV1uTS5w
5EKpl+z/Xon/Q7eBQxsIGSUCKJy/MDG/Fa9nkZD3KQrxjeljIr5oZNjTsjhZQUV1aYFv2wfteyjH
tYVxXr8GwmCubg30tNyzJpNTjVljsQWo9xHG9mgO7EeUCA6tV7+oxJq3OuCySsBw7/7+teeAol+V
c4fque+sjX8UkV7X6k0jWQsrxXpu26O1SfHKxc2sbbpjVxD5EJMGFwZmdtfwjptN27T9CRsi34zV
guPxYuAm/s4b/WksgJSAK0WbKUR97vUbYaJEBbtlLEyUFh6ERnbKHigtjNPyox+g2VQG1qsoYYrN
Anf5OLioxkaunmKRrXEsyhD72gh+4knanOYIriIXRkka5dT+v18rHB4O3QdvRbWdD56vWp0so1T0
owyXIlNfXxlQEbYasuSNqozkMSn896yNfuGEzxYLCtMu7DkQaEjnre2X31bo4OepTntExcthBG6P
m0ARj0XZHkB6FzsTya4jONl8X9JO2Ob1ZO+d0kvIez33nSbZujjO3wSkyC+8MdPln3XtDS/UErDD
6mbW25e4R1k0ORzvpvTA8v99Waz9rzePQu8MQAeNBeCDrz/a7lvfaGFc0x9zwpMrMkwG8Z89/i+e
sroWOwFdbFSpXz9FrwoIKiBDdFJrQfxEGo+1FO07DdS330ICE3G0AJtaW5tnew5FDir5II3jXi1y
XzuJTXeZxtV7VhZvp2fVfmTEHGCk/6g4/r5QqslChivrZDxn3nSh1g+RqbvEy1jk/3olhD7T8suX
jfk5x6Z5RNGBmYEghT2jTobEOMKGar1rFX53/3aOVgAkIriwYfjbWUf3t+UfWSU0voqonSsRXsJa
e6Cw+C7S8gz7iEy0aaF1BvgQSy/wC2cLDpCRYZctj8FnYdoVDeVirtXwZRocayck7hmeSCZkwvD1
w3uLuKORFGLsxL/5+/e+uZDoZ9rIPNH/hpngnQP608BvIWxUDaRTqFDwPbma6to7lVPbbHU+OVsn
jax3NsKbQ3htoq5Cn/yF4cu5t0AAVlzl6xKt14zWIZDcJAqRFbdL4XrafnoYTOwLy5xOx98/9+3x
xqM9wP4g+7gN8Zl5Pb9oVTiekfO9mYt4GSSYKC6KzCYlruyr1kgtlLBs+6bwW/vUD5JIvgjolCb2
9M6a/tPAs8ZMwBTsVSw1zl6kT4wOJmCDgkeuYyOXV1WxNiM1Lb2UGsblYobtxd+//u24o+IHGJtj
ARJHdI6D8sm+HczMU2idZXOYB1vFS2cColwZuUkgodpIZ4kznAjfmfE/jLsHsBRAzarIbxGKvP7c
LjFoS2a+jCWM9TgiBjhR0SH/rtP849S1YjuLst50hsh2OYzSXdq71ZYGd3r4+xi8ObY4tUCKgxgC
bAT+6OxFpiIUOBiFknluUwij40RyTaxejGH1DmjmzUnMoxzLN3kKwYZnnsUaKJQOducR9QtUYS9U
CRfSc8x59/cPevsUVtGKeV+BlYzw2QfNVpa5/YQinjLN9oDST/4wGcp/Z7m+HTafE4uzCjnflcly
9i2dNU4hqot13DQkk0NWiUPmCsANA+CAv3/Q250BrIML38X7JYzAdL1eKkmh8H53eJTRZma/GxvX
2Hd5CMu/8KmZLXgGQUzV4h3zhrebg3uZEMC1bIgYmLa8fmyuWkPX9oAwVWCI/ewZzgn2an01WON8
pTvb3FSIGMPMeO80/MME8uDVpOKXEc25g4BVjmYSdr2MA3uaPpRElls42+Li76P6p6esMsWceWgU
85GvP89LJpC/q8uSW9nhdS2Dz/hCNff/i4eAHQW2BYrLPre9GXriBbMvqdc5wr0YIbvfDYv8twh5
bk/AfgCZ+LcLk+U8oYGi3w4VFtFMVe/eOONAe5GY6ApJCpjZTupso7zMDrCas/veROlr0b1ABcvD
zysrivqi8uwcg8TJeJLeEH79+yCcg8Z/vR4mf1AogpUpdy4RbA9TbieU/uKm8n6aeaqe+0Y9+OMi
T05EsaHUs0SuFWlQCMdBf43ERr2zgn688VNYvdKdaBJaxfjp7+/1pwWOyZnPMkf9EGLO6xXQ4jEL
QjaTMWpoFaJ5OT2cAW1FVGrF5aKGH2lZV3uEkb7//bl/ODoQkl0zQE63NVJ8/VzqbSFG5iwK4VNd
GZKQ8gjqxvBJq/dOKeuMxbAOPc9acaAenCPwIq+fRS9zMBaVgyoSFVCipjS3FZSdXVWCmepmgbxn
mkc3UtfBjRct6DJFy3vsuF94sFfZBC9BkAGEH1xhAGrs9UuUwLR76i91PLh2EgPJhH9O4LEJTN1S
xJ2LozVP0SUdjOlrY3T2F5Rff7adbxGA0CBRtpHdihAx/kEEyV3VliAr7Er5jxmG3Vidt4a1Ha2x
tuLJdKO91SYt5mnoXb1z5v9hwWCZhm8KZkCrSvfZxFXEZGPS9IiM+en07KV5+JBQHdp5nVc/LEFi
fLKAE1wDFffeuQLWaTobQUhIaw4DOtLDxOX1CGau2TUmvYMYAdb+ZQwT82CCin0gjDAf1By9tzX+
cDj6BIVcax6gQkLT18+rwRnZZmaj8AO68IEou7+da9d5J/j8w0bAaRk6CeE91/X5ucANkxewMxF2
ypR6NGtHXbn0Y29DTIPeSWitNTk+G0HuE4fJI5cBZX22BqfOczlh2ipuO1QvLKcqKbPN/QmZGdAa
XQo8ZTQt+tcmeyW3m0M7Vh+tPLmiJJWc7EG9c/i8HeHVo5Z4G4oeiv/u+r6/5VUNcjGiH6oqdg2r
OLiaMLMB2bj/+1Hzdt0QM4DjJe3lGCBcef2UyE7n0mEPxejZ5PgKUq0c2mi8qMHw3siaHsHfn/d2
RnneqgUPHhVUun12pLrYnhJt8jzXrvO9dmm503RO9pnU5r9ePDxqdTFY/8VSPfu0nO5fqRD4i4O+
b4/eGh8tqAIfvTx8z6HpD3O1hshg7dckjWD9bBQF4I2gZMUgKSH3XuW7h2ywjHc+6I9zBUeHZUqQ
B8rn9VNCKzPFNPJBCVgapslrTzXtjrjD0HiT+GJ4JwD641z99rz1539bgQHiNHnYKr6qRaRL+Uhp
ADUv9tlUvVdE+NOjHO46LlqMVZAleP2oNtLJaFh8Gmd1uHHdAPGarmxPRp+6x3+/ArnoVqp8FNCH
XEf5t69K7bGZrAHsRtF07nHoVq9BJDFvpNm9Jwd/Tkzkcv3Fx2f/BnRNoAq9fhbypYCkOuBzNSL7
L8qX5OluEd41eGPBGUWnEs1at38SNmqUwClwJcxUEhdeo5DGVkm47QCegwDo0JmCZWG9sxvfrtv1
/VhPFnBtmKVnZ4zZETI2SJaD2BPNdrISzJ5opL5zxryd3NAmhvZtYiky6fN8i9Y0VaMhQO8MtOEh
S6ryqJS/bF3hqXce9TYTggWz+oqtRH2KbGfrSKLkhgn2WIJCWmqEg8ok+DiFgGxmq5vgtpUBqoJD
OL8XwL7dmiE1KT4RFyWS9V+A+N8WVRKBsHW1B/RiHv0EBZpU08W2uovBSk4MvHxg3vUlq3y5sQe8
xmcUdw9ZptNdE1CtQs5vyJ8oEN6ZQAg+WGpc3pnqt5NAFcYnzMJZhjDhfGTSCCloswNe19ph/2iY
qbzGHgsQHoLT//qcglHIvQUXhbOXBPv1qkcH1KRpg4VDaUTRF9tG4HEAnjVtW4Qw7tSczdu/b+m3
yxh6HLVOz+JsNKl/v35g0YBFUA1VEjTp9BNqMvND2C5++853re/9OkIgpltZcSsfz7bOOSiNl3gy
FBP1NxqJlwvCxRsH2R5uaBxtVnQ2WJlhDMcjKnI+iqkAwf71d5LmEyTjwG6S+55dAAIN1ciuaC8Q
QeMxKvtiJ7Ipffz7U/6wUggiMTVZ0w+sc9af/20tczy2IO+6goauMzx083BPUbb67JXcMn9/0h/m
DW4NhVT4PNzP51zhWSEaNhqIXwkzSvYJYowvgRk1H/7+lD9EdhStqJ1SOqTcY59btfVQafM+4INa
Km0lqM4QCdg5Kba5iNId+m3z1rU70BTl3O8mf/zWeTo8wF9BAo8W394q3nVb/dNSYjGtGReSI2QL
r8cYoGZClKUBJ+WZvtUgguNa0KVHIh3oCHuY3NtPauSpFKLKyn/nvHoz8AwGS4WjGLkAhv/smORE
xObHc5INGsfiKTMicR2gD/vOfnmb1hNKEw9RdVgrxwSYr79SGCPuGD7CcSYgvZlCUJYdijEBgl6X
NKp9IdDnLZC3Sy3Q17sqW766+JkfBEDznZH33a41yuApA1Kw/bUm/i9Ip82P+rFrf/zoYJ3+P6Ca
wo/7bXus9mev/MmO9XdZA9lhwfwP2/TX7/mHbkpZ/T9r25viw2pqaq+J5D9s08j7D+uOi5zuFdVT
stv/IZv+h+7MegJDVLWo3HocGeCpfvmTwVGNCOlJFC0i5IBa6L9hm9L3e3UIowdK9sDpu7qUwc/i
LHy9ppAkNGtPFSCAC3ASGv/wqO2NrZrbDrQ0cJ8KzXzDaxBFdHMsxvPe6WLuUxuaT+X6eocEqOFf
Ao0esGxBL3jeCgq1alMDhymR8fRJtIww7ccNPApz2acoOL/ATNHw1mydvhSwa+D3ae3pjZB4GGxG
dHsViHdnbEDL7WA8GMaXPpJm8xIMTtjuAi4uezPmGSFIOKOUjyhlNGaPJZXZLoYnQ7IJ+yNfZQD5
/uUit/q+/LB+h4k8mei0HfORdfiYgkn9mAy4h7w0IwoUyzUBrFWdkOAul48Z+814LCJh+odqtOr7
HspCgugQ/XJ+DUxV0LyJabeOiWTlYFYnwlAT8RxDWLXvbe2GwtY1iKveePScHrhqPk0Z4Gdlrr9F
5P5cndoyqk10z4rC8g+Jkbk2aLhilPe8Jj+Cs0fhnoSrZo8AD5TedWvz2z+PSLWHp1YGqfuYwEF4
7rWRoDTuI6LebggkPJC5QV8IvCsSMfbQ+uQsr3E1txzglk1HGx3UhLPyjNrcpK9emOnOFZaY7h0S
LvWSqU7KW2d2RXOdjKUlDgNIaetT33rpJ4XinnEHJNHtLlCyd/S+KSZP7xPTM3EVtGv08xb+56SA
FhQnP0DO9AjPi1Gtqrkcb41lKYofkRxN93qxdK0PY+vI6SA0Q/es1ovsEc8HX70AZ7PErVdA/zqM
kpk8oVsHI3GE/1ntK0eMyeMA0e9jlsqsOiKRbEEIRKxO7DMhbJHHuYQQ+tlBi3iKwXA13g3CwnP/
g/Yec12npi++OyYiX1dZ77rFV8Y5W3A5gnW5TqxGBjguGwLkjz1S0kASA4Uw63Prpr1PdlHP65UL
fQbmnfDNRt5WRbPYt3aJ9OdFbSf0VjFoCKJDmnfAsbwMkjW8GnZ5dSpRWJzuQXFoZyvtrMzuUl0y
eEMt62zrleyFTTcF0e2s06E+CaR/EGQn5bvKTbsqP5kEwugwRnUZXfQlktxgJ0XHhgoLozv6ykv7
YzYbfO0QFjxvYLa7hyYECrCpdYubi2GK6BNC9LI/1O5ANa9xwuzaxAfPPgRTljUXGeqv1tWIKZN7
sGBjAuv/9c88b6rlY+HVHeqCZtrcAJ3yxPU/L42ZK8u3J1XhMswm/ruc1GJ+DHsbbiKcuPnO9Rsa
AAn5f3UyfVRbt1My5agj+93EwIGK6X9Yv1ZkakOEPi1JkKhn2Ypiugdxmye73s6FcVEH4+xf+sU8
Gl80ZLTv2CgAOC7N1C0e6rRMHIDAXm5YzsavgUeeUoKk6Z5H2d5xVkOT71rMQdQmaxxAvo0DeNVB
WHradp09C95qxhsnBG5g7goxSh8pwsII0qP082L5+M+XismtpnvkmB310jjpuv59q4MmBHNtV6WF
Nr8MIVrbV5bhjSN03YKhcp2Kb08QwqxOhezQMqfqlziHKHUZMOiwnfl56gb91GIHNYM+8PUJEyNb
nGD2YEgTwMKoTqgnZ/0xTxEqvq6cTk6XcLu76INM2zrbBcCLuqMCunZvgnR3Uc31G7HrPI+FZ1kL
lhEbPafuuO9FFEr8rwzbPyxQY/UeOQCLHZg3rKLeEE3Cxh/EIUkiJAGQ4F2gII/996WxZfYAvLtY
LvvBREGzpbWrLyKvWMkQvXIOo23hHmGXbMhri5K3ekDtPc++9ouD2YGepzThmbb1Nc1xVsSATLT1
dF8WfNURY2PWMp6HnKPuGM1snqrivfG1o8lx6dtgZfmzEX/F+KVOLYFjWDUjJbWxZmVkHycsbP1V
X6aeboYgKUDFD0ZQQ3ddKH+md0U79MOVF044bmGVZuc8GGLvcMK9W9ewKhLfqrZuIQzvKhWz4x/y
vmR+BsOf2h06mWg0V1grwUTMZ19xNAlMU27zAJzzLd4MaI1ugCHb6qB1ahk7lqQfYQikIZdAujM2
btfU+39+uUL2We//2WUzHOvqhPppWT7m09L5p3/2XccBOF+sGnhUUmd8Au7rRgESgIDfLU8F2Ya3
bcqm62+QqhfmPaI6Jbctct7OldQ5fx4nCPk7VS4IMOmwBf7ILk1DFSm8fMxpCO+jPkr7Z7jVQQWb
jVzlGuZF9d+Unddu68iWhp+IAHO4lUQlW3L2tn1D7MhQzKHI4tPPR2mA09tn0MYA5zQa3bttiqqw
1r/+UN0ZuZv63rq2UADAepaot1aT1/D9XDe/FNih4+x2+YnNXLMwr3+PXlNqT4pbnSuVqDl8Z9MK
PBQ+s6hvGfoQlXI9rvLLxZcHvphfr9sklhFX8OR2zqi2qimXDQ2H2Y+1Vd55TT+sqpjcp+Fa1WKC
8n+ntzIv+7s6AiRngL5QmMA/MDn9zJIp55j8Y3qWm6SLUmuX6CiMXvLYnrJHPEba+VjZjhvjoVoE
5IjmCF4BIXIwObh7pHegGmutTezbIg3RIEqqD6NC7SAsCRrHiMjl5pAsMTyQZq9CyI760oEYOxrJ
iZAjSOtxa/fDj9pkLv6mZX0xcu/Bwy7wDE2PrJ75ya44xTLp/aoru902Tn5OraAIVVA1pAeKxymd
3xzQ07DnpF2z/ImRmp112Ttno6q+5bPF6nRxMXaMrSlIeynSe3bSeiJQASFwTnZU05/zRnsYamoD
oY5jhzaq75WzLuLgQYfRcLIGh1MuWAScri3Xc6TEEahsS1DI5FM1otLf4/jaTaFu6Y9R5JU7WQ32
EbN/9BTlFK1Lc8SF3heSuBX7MBfyUJbuh1uPr11VYJczTSr0Y+PRsOUJZh4hjIB8VHNQmDsXMEy3
eyQVhtv9BhCFqYdKNHU3iG3je4bosv9JKLeTnVHu+N36WrIYse/3T0XdnFuEdS4CyH055afJ8+69
0t7Hlnayy+QOh11tDX7f7Gokx0MrbtzJwIM68H9nU/Adi+H2oekIcHNaO91YGZbKzoCwj+g8cgRV
liy/rl4Zsn/Rm3ECmNQ3RGPcJ7J90uaUgKvql6X8GtY5XVyfW89tQh6SQQHujskNEZJHf2zutSjo
ji6yOdOYEHLI7CcOKLupQdyTQ1hmsOuuzK45czGdCXlB7SO8+3hSH67mPk1zSkqtJ6sdMgAfgy3T
esX94Lc/MnnFMjZUcSlDM3deseP+o6M3COdk+BXH7YtpDcN6sPAJmKbxjxnNDy7k7FWU+w/WXBzF
EIRJXkVPdUpBqKk3r0dpVNcDAg8xH0dnNjdZ08g+1AISz0gk4uZa4wysrdjQZyPyd3rm3XSO/gsz
KnlLDYIhWIaNQN6PJ+IstoWdnZIaVncGHXXj9SBfBQOuXed53zPb+D3n9UMjrCcIa29q5C2tSkGg
Y5gaXjhigL6d0Drq2pTBIxXYfKNDb9If+JebKYu8xYZhYBpElB3qUW5226Woi/K0j24rgnaD41Q5
ykMGE0UcmKpPb+0AosYZUNDBNJCIkr1F/JMKidHLftW9qfUYhTt9iiEFPiTttsYC4cPLiuxUxAg1
1n7Ug2n+o+u8v6Jm//TxuUAM/wHTPCAPTi8shAGaGPniY/13H8cCRxbY99NWpNKz94z5fPdYjQRu
4ltMYNe+IUsKwrxyq6gNA10zmx/z7EbxThtT09yP4yCjbSVmx1537pR4jxqxjG+dinr89jArx/bA
zux+p8V4TpzkTHLXC6bppDHWQe2OZ4RPyj988an+HgAvn2phw5qODW9rccH7hJ0hcmx7z4/HLdkg
1CwEaPjjBu1Tpm8MTubmHWcEypRUpVPyKLM8I6c0ro3oe5aTdjWtmEtoTB8ZJgTuvlApMqrZnSi2
em/kSksupbbnddZvFeSLf4onfdncqrTlViQugxItqfUyeJSjwEfGmOe5PUXaYMTfamQm3R3Vjhx3
jq1xAf77Z//EJOCzL/xME/x9GYPZxmeeWD/7lcGwdNrOdkkrIAD1vOM8YmuxGMI2mDzEXOXbCOTR
3hueoLrFG9ks/JWqYOF8scD+65tg9gLAxsJi1gNZ6BPChmg4aBgmmRSlRPe8wqtEV6fl9hBtMW3j
OZK8z5IDpAdNrrvUjaqv0K+/kQreB8pbWFFgvbwXh9v47xXeexgUURs7u4oYNfdNaQE7etVykBC+
oKOxwra9qd9ns/LdFfzyoj9dF3uKawVsxlih3vvirXzCQnkoxBRkh3MyMUNcRomfHkojvtIwRAqy
GST9z0VY3v5qknGplzEyjXdxS+UGwh2Z+j34r4eSGIp3eVuUqKJ2+HOUI4kFA4u4FVVZfTWFX17K
X8cCfnMLJcUB+UFscHn+f4DPBipIEshisdOLwO6eiRObO1rkCrN37gmHfFgIcGb37Ch0s+gjAHO9
B9TCurrxHHITv4KoP9EwlxcGaLWAl/BfgWo/7+isADPxjDbdXdtcoqvYOeQoUvQmiIfEyXdKXoZB
5mL8MyoVerhmJmj3DxBbN9/CoMqopv+/W23x0WXGdaEqMA349C2mwtZMiDtiV6FfMc+e7iXjoR/h
kd01ozKLEHe/Jv5+rYMb/giWYJUd9QeLA+Trx7H+60uzfKa3CzIISfS/fGnbCpDIJOd2l/oWp56K
W+Kg67G0TpSprVzj8DGSGWwNjOM8NN8mZ7k7OxzLiGl4qiEmBupwLZpnXIW+Iir+H18iPC2bwbyN
ewsL/9OxbNLEmI5e5jsxLJpIc16ujqQb9bsyw3tlVfmj3x39AbENSOLS0ATSNe8LJ5DRo1HZc/GF
I+anQn1ZVj7IEpA45I6lYl9e6T/WuRfhWYp1RLPDZMQjSjXzaXKE3c0PjUJLBbt7hmKb92l8m9NW
c4hcelpcImS+s+GgBDEFcJFvcyI9CRHoe40cpXaJgSgEarG+y1BXT3ArvMNU9vWhIshN35W1QQoK
ul5L39f25Dbky/SeRrIFdh27ro+SbRtjPRP++4I1lxf897Zm8gvnA5yTEQxb+++Pu/ilTCOQza4U
suiO5GvxtRcmahyYH9VUHbJSK6ZtUOHqsIUfnE8PlUDTuJW0e+2mapDDrcaaPOFNEWTmEBpkoLlr
/HHmfTcxWN/gNEXLFRRVsGR0uWW81bTSNSjQW5qcuOm9jGQtUy9mwnU1u/hVURfIL5Qkn9wJ+Vp9
m3Babn7mWTjhfqbT2Ck2Of3cZvs+sui5Ro0K8BaeGkYOEKUGeVPXbhBtkgabqQ9c4NNxjeCrzs/K
Gt38eWpNlX1vWoJswwz8zCMAxvaKCHPupnrVYj7zbiiG/CsLwc/XAqNhywKMQcO0eH5yMf/9/cRt
Y+PVaA7HOMMWaDMNXuc+BHFMxnfSGEEbkjMymHdVSoLlNjAKUeNGaziPC+frXZrYjWxEb6EDS0E/
v9q+n2tFng6z98X5D3UiD2l92izObNXwrKV59HEsyNZ1GsTeQWQJUSYu1IiQar129tdD2euaMVuT
hs4Ca0yV0tb5TvroqKZTe7tBin8sKH6cAyWWF21x64qeoyKZ8M52rL7djzlmZA8ZqdjiKcfy4qOM
ozT+Yp2Yn645KAoQXQMG1ghIdAiP5t/vG/hvNhzKu+P1VhGavkBh+li0J8JkALatClLmEdJj360Q
+Q3+Ipoz/EPdtyOmRMkI0EJQYiHO4E/Y9ZRG69zUTUSIsTu3bbaYqZHRtaJp1ao/wFGiDU1hG0BR
/761lzr9PzubmzpgzI8c2rWMZZb4mblD0OpQx0hytkTOay10fSHNDpW3b27NzjLOJPnRm2FfZKl9
Sl1bPgLdDcNXuSSfqs/Lc9gLTQ6WCS+WluLvN0qUpgtbblbbxG1ce0/NbVq7sova9HGgXieZKQXr
PGEbKOnUstbobqSbp4faS30MBv/9pVwm8f98K4tahFuXk86E1UQl8/fTDBi1uQWi7O1YlNofPcJ2
JWycurgzCVnGyAa1vdq5g5OUd5bdjy101aQqiZRugymfb3onBq6LdMy8DyA23EoekZb8FQ6Hu8uy
dAFhu9k6Dy4UxRMRjVl3bpUzlE8FHMcGT2J6AXUOVN3UP0BlSW7/90/46UqFL0j/ttDdoFwszIvP
xHXoulorpywiaw2vrse6AaFmFodPzUstdYg9klSd8cX04Ys/TpGk4hY5kWXPWYd8/g7yrpo+/v2Z
Pp0TPBOuz3CtkL5xRWCevVTk/7hUpebLgUiDbFfwMOxtjnm8+YpOG8OgEC1pPnnpkd+ESbML9GWa
66m2dbGtwHfNt9gDBv8TEHVXnPTZ53UjmaDAUx5xnFsEniMW45YQDBWbvAvI71saSwPGchuOqAgc
F5Q2yIBk//1jfWKR8bF42Uh4L/Qihwbr09LuWyY9mq5XOzwDQM9dHO/eu8sKIVGKNd3Luu6w9xKp
+YaBGCdkhpoH1/uuZZ1wW/h3mQ+X9YgNjOPt1MTphtHIMm/54kk/HwY8qUlbv9DJkMZxMvz9BbQJ
dUVEK7UrKmyrwp6MwRR7Q5DPdy0YiKhPufH7TWXMlbfrUl+SI1QQov5ARi6eXLW0jRssRQKPxwNX
2nU5AUaeyM1qi6US3QYTJ2Z82TDh3WYKhzryi0/wd9PGu15YY5czhFqRQfOnd10UZJtpgT7v/Dax
mbW5Ob9pMVBNDjBlmvSDWSolSukqBFEc7rb3iLOwNm91HDXiDXmR4vu/P9KF1vnXWbIELpmI3+km
oel9VsC3jV7XCRLmnSIJFSuxyzmrV70X30da7YqXKi8ykUE9YjHD4LcSh2ultbAJyrNw6O3cwrgD
aR6aax818ioipTLayhq2DJm3jS8fa7B6zswgn4kfxYI1nV6uTfJUkoo6rnxTcLbHk2bZ+3ke2VUy
QE6ywheO/LcVsAr/yOOQpziYHPaDjcRVnK6/KE6WfdIP2B3sW2oehp3FxJ+BXwpM4GKR4h77Anfp
4whKQPFhqh6NoSDmdnM9PjhoFLtrBFObXpzLf+ABcjN07AZX3DtRF1m3jEyG7LHC+ji5B8PEkaSs
u6Y+zXmqpavrhtYig4dwJtmbd9czKdG4+18U1pE0Lk4yR/FNO1RZdFuD5kVb1wKg2+ZBErlflQD/
tdIIkuN/CIwgrHn0vH/vlSi2QcrRdO5qsobL56omoe8Jvygmzq6ueGOaahjQFQxGRGhrXiVCt7HS
wFh1WPZNYd+M/KE5Z0j80EmUXze1DIJ8PV52PQ7NUbudRGzLjZCTr4daJkT7nAgPNKmNjC9bmksV
9tc6xSAANtey+aE0wfn4+wPVpSsLjlmQO3z85ONouAGHbeXHVkgMHcHGbqxDXlvF4J/9Sod3aO6S
ywmb1b4lH30CmNxjRu1JICqCXg/GAbNHvq+OcLQtTSUrznYa5pVxxnmxgvSt4tshcYx6E/VxV6/M
y0JssZOKtnavenSo4KXj1hotpITlZdm1Za5pBw9TYHHGUJMd5Vt61jGadXvzKZ4wHf5iLHPVffzz
1aD/oyBYiO/IC9CSffquZwRyNvbY0U71dTK/mnVuRTvwT+0bAhdaX2x8GJs3Ix5Ke7NOs/i8hEOT
Qa+wKQnhz3LKEwpXROD8iVvcl43lEvdS5v2plEFNFAsvL4aIOCWMP1LmMGgBJ3+GaHuZ7DqRNTr7
IZrADTsz7n7IebCtcPGOebiOKau55liju+S3pqPB75tTDFY3k60c9RjNfafY1E7chU6tV+8YpjEo
s3FWFaEYYHs+mJPB31dawIS9HwLuFjKaaODoPfnCGK/yT2woftMPs9NHbNgyQshjRkepGOxtI+nM
bq4nQjr1A4M38F1kaBkH6rtRjF2D48XEz6jHTlvG45HUmx8NiU38iks13JdjOr9GxLaPN0Thdf45
h6HKLci0Hn1gJQFBgGe4QK+/pk9tHg8MkHYhy2Ac4FwZIaXeJZUHWUKfiF547626qe5UXNCoXptT
3yr4wlw3Xj5bPSQJjJrL8DtIAq6KK+5LDzgNvzH0XO7firiG98js+c8wAWJLZ5dhbJ4kVHc6SDLG
iyrxivLm+pvnus5MwnVtNU1omy40levE/LpcBy3gY3nAyd2x8EkgxoaXVGgdd+W4N42d7IkF240e
8qYbnAr5eMAai9cpXjDQXkSq+m1+Gf4HOeGuxNGVY/LABMPzCHOFlcg2wwJS+GvX7id5l8d9Uz9I
nJIb3H2QzoT1qLweSzarWhazWQNFbxxEScz5YjHN5p8CKr96yfXExUrag3VycKOU5YHVKGdWg09F
c9IFOoluM1GUed/g1kbQt5IK9+NE0yTFb13mcsO3P7i3lmZhMrmyIJl1oUXVYMqVFxdM+q8ggcDL
SoTQfBYOwlDV3fv1TUmCKflJiYCBPxRyIZxAonpPNcvqfyTc5282BmHDMe8Ni1HnTErl0jPys8oK
m6qwu8AULiIfVtxc0qYCMBglC3zsEmZl/mRa82Pjem3n0t8X5MC7JjgObWxQ7vViiIEKtb6DAVMp
2TUhMx32V+cqNoxXF/V7jJ5jj85VT+6vqyUqJ88/g9LXP/W8SNu7vuEe2mWmiuRTmY9F925rPi7f
RC1nFgSuiM9yM5NEjXLpektITTe0X2U2OmthtiJ9jVsNa9Gm1sdyFWjUZ/sxcrN4HY2jpx8MSxvK
oyfdbt7g5tU6IcyhMd2VNMLZ+n9PSGlafHsY0uaYl1VJj9ewGXvm8xSBWW3rCzdkKlvBbuiahPeE
cmTpWqJ22SDXNQyhiw8fjyMfPsGzFhxywDvNfi0MB7dgGWFG1+JsuPIYZKjnsWQtPcQ4+DLbJaFE
uZtexPmLOysZPxjjKN12YwkWLKRhF88/Volj/7kWwNAEsFjxiXuowFWQyHR+AOB0uUvby2ELazB3
eK+Oty79lq7q+vLsFCx8nSaxMXE2NJA8ML5iIkMcysI7mQrMaYlmTzRscptUnTzhcFi1qrais0lj
4T2MqHGsm8S1qcCmiNsSH1orqKYPJlVeNRAsTYTHt+JyZnmt47YMWpkejysQIE4cNyi1+Wzxc61T
Vpv1/Hol54gL9ysdBsM/Qfaofipw1OpEcgFzcQRewyaKjEnuwWGX1TqaLT12bQfEkK+FQXL33mU7
OEcGUJbtrGpDdHhXGV2nUlzFek7WuM2dYuck7aDfeqLVfGa2QzPtoAm53c51U1Xe1NbiEByofkad
ilFv46yztMIFvjElc0vw4XZzPXMwGluOQMdiEV15gJHnRvrJQdRXh6CFqto5XAUfwD4KeDIfgvlX
6hUFId4dnKJpP/her5O0PiT5MW7notm32PRhuthj9LsT0sjMnZ1NM/Cgr1eYX82wADYTw15rD8BI
gZMiMsMQUdRlIW8xFjHSHWmrHIvKibjhmAqzUg0zy4aDiVcPt0TaZDksnEyv4clgLIiKkrFNYhNx
q3GIRFZrld9kx90YKr1q38kpgBdqOFiJ75mjp8nChJESXmRPO4xDnMOKz2SNpzM4DXm5brxs2gzD
+lDiqUXWens5DUga4JpkHV+uSf5Cf0s+eKTwP/tBCPCyjZYzfnqAWGFV39JUc4bdrFkLnI8k2jHj
TS59zXvIu8GOyjOgL6xFHU51dQ8BqfEekaEs30U0L3eZMHwuvKYi9lxtfcg+kI/MwhP+H08fxzlf
W5ikqqfscrImBgDDOvGGAnhJGXiJcy+xEqztdLlWwdeX6vRSplxLCOdy3F+5cEQML0/PQa6fo1n1
8iEWHF74uznCfpRcm/aOSNT2C3cCSqylWftn2QWyTkm6SKjJYFlk/H9XpF0/qX4YtPgQ26Wfq3VT
GJU0uP/1XMRre6GxPOJOQNVJzzkCtkZGDG4wZt7SyFzmlFc8tLPyzrwbTYte4YprtOUAHqrFWZv9
qeeWFqZwivYHnn1pfabZ9p8wumiaQzw11rtgAI+fYInX4EnMODIeTA5deLnBQHkrIkxVnqZMtv25
EgatSWUj/tsH0q4/Urz63JB5ihg212dJ3GDpxSpwrh/8nz84OxoTdDAJzXkDibPPnT7HHk3d8lgp
8zL5KMy+qDeoyuw09BN4fZvZCZIWc3fd6h+0qKKw6y4jZvAQWz5Gly5Ox63IvMNtC0q5F7mW9ieb
Z+WEJHSr9ImLFmrp9XGEcFX04vbx0i0JDKy3UUC2cwtnCpwovHaLakh4AVipzu1O2N60n2O7CUY4
CrpTvbp1N4lHT5vgseE5x9A0dFwY1X8ARJfZ/2Wo7DWmN4btzAfedgj2jDd9wAvgj0gsirzrVza3
NldP63CUAPe1IAhcJH1wDDKN9yGlFo3PRTNFL03d8GyFo/jjJYxB8+6KdXdqnhQahZSz5JV+yZ9P
OYat+Yfe41/4o7VnnApUnP6u49Ir740+du2to2tv8BGD4HDtnBu7ZrHoQcKvWOgP/Y1TmAWtiIVM
7HRtqNWllSaahUXXpbaunaIBCDfB43RB269376jNC8BU9ENyk8yx8asXuix2ASYO1t4toe6uqLM1
s8TEr+GIsTgGDnCpuuZHb7I8HiEcB2pfWIkHZY6pNB/Nv7TqRZmoYj+LXpevhebSM0k2Bjl91VTi
JomND6LnDATA2Xrp4KdPcdv7AKw6DLjT4muu5dCMk4zQgmykx+4u830rCyShH0Kl6pBH/cLXHSXP
5prfsC53D0aZ1aE7m+ZT7mOebA2zDSGvNtdxZHvbDLP0vO9tSpfoLEYIYG0RWL9jFP7rDmgDcxNN
21h+7a3n2nLCUmjJTZGq+pbbl+RJM+arETYM8Bp2c587PXy2Xkz3aWT65Mg4HXEzE1EXeL1HZyf1
fs9wX7aF3/ahNKZHIUf7R5Vp6jZvOv+JBPph347BdGwcN7pJ4kk/aam/GHHqNramLUj9XMxnWpJk
22Cu8VB3alzrulJw/LSqGtYcrt6JAVC7GaJqj0YAjRE/7JiXqdz0waDDu5wHg5C1PPnosmI+emlL
ZWPkZlgquz0ZyZy4K7jH9pspU/0Hd964LnQvWOtNZuGtpyWnemzsfdf01o2yJntH+jhiLUnB9zoQ
E3BwmuZZcDvSD9NFb+gZshuOY3VTcUFvJfjJuQWmwIo1Kjb0xHY4aRjztlMWmyQBDB8j8M2605X/
gMVB9mbPiTzYoPnxigZpWEeKpmuwSHfH2V/dda2G230XULh22nQURkYuKWaZIbfcuMFTMdAX2Fjf
k59KNEuABH1jIc3HfdOyf3IIOwZ+z6o/kg4zbJmPdQ+YPiSHwGL+peeTvuHa+dYUVXznJ3giBxYI
PsftbaWl98U81DcgKlNIdgwdiZfa85OSc7nVFXPfxfG3h0CMZV/YDhGkq9R60YWv48rmER5raPGP
eUQerI1G/jJU0289yidYcvY+zfzyO1IyXW1GUjb8p1q1CQlYkfNNeDLeO0aC/x9eqlPPe+7sTT0h
AWy78X4mHWcV0xSsoPaZmyBG9BQCls67QVW9G9KcYKSv0FVz7MykErV2Gz0bhQkzzxRzsK3i2joM
/CuozCkxOA7D0iWvAFEJ59vcuTAHLZpNOSftHhKO9+FoHU2ZUQT7oNJ+t5YeH7vMcTGtatSp1Bq5
MjVb+6iEnb3ADIBFLpv+tuqz7FumDViZq9wsb+wI01ltGr4XfWnhJlr5u5JGcQPV0Cf/tR/QzXic
vGVlDcWqNlNtWM9VpG88v/UeKprFkdzMYXgEssXQfwx487kZhDEKRuJR6qD8bQxj/GtM7YdMGNGv
IvOme6fGZ7sajOltwFhLY8o3BmFlOGP9bdCF+S2aAz8MxmDAGZqW6tkzZHBbWaN5Y/faY5RFfPdJ
m2xqAdMWY9I7zTPLam9SGOFfkmo6RklkceH5x4Qmtu1spzS3IodbE2erhjfJSHx+Q/DkrNE84ZpH
GMWLM2T5jZsHEbvbbffKm+ywNbT8tnaxtBRaHew9dx6jTeYUAzk7GckC6Nxy/iWRx80fQjHiuz6w
3Y1hNO2xiN1XO22se4uKJK9ozWzMEEKG7+PaH8SMfHiJu7DUE7Sp6B0cEYPqVBJcQXrWUwXh8T5C
w4NWQsX3idLv7Ua06yHH6iAbsQstut5AHkIyZLekvXT4MmMCZYpuR/RDuqmVfMI/LHmweve3L9XE
eSSDAxJXtbcYO+6jQWCuxi3mrUWWTx/CK7cdJPvbMU3x0a4m47vbGLNJgs1ImAyd2RoAMH62rJnT
3qnaFL+MwnxtnNk4x40uX8oga18CbupHDIdyi7CJsTon0hUryvTuZ5uX5Q7JFibqbAOYj57Y1UYA
HdCFkeo7GLc7qVTfJkGYDkvSzde1cvxnM3HjbRRF8XrmOKHKirOPIO7nb3MNCWCZruVh0BgOKyoI
0rfSLpmk2wVHYZ+QOTVr1cGGCbLFtnd8Glz/5KeWOlhl19zTPPV3zgixpZ8Bo1nc1p0zBQPGu0m9
Y+yt0tXcevI2IxvoVaQwOYO2M1+HrE22euZYP9GeLnkAVfVr6Ab/xmvaCmTOnNpt6+HiXetDik00
L9TVlL+lNiGgRcOM2EoTSRzYiN10bBffi1YvbrMGlApjvUC71VRL8ooEA82JB92ZyVjs9GCiA5tq
eR4gaENhJrKmjJP4m923ASgYb2TwMv0dD0p8bYNk3rEb1IdAASrXSSm8UDT6qK/YyfBBitz7Oebm
OR2i8r1UukXzPBqEfbRV0K8pL+01MVZgpwiWc0Y0MkMmWxjfnTimros0N8xHU5tXZqy1TDX9odNX
pElY48rxtIXsnAx3wsr7t0Y11UOee4EKjZ7UD+Bw0W/FFPtP4FE+SWnDHhsSexdRzXzTUwBIlCFh
rgocrH1S7OCRBvgrYOxslhzsXJP1A7djt0dRorBv7qtbQS26GqwY+NgQxZZLJ99WVr7FxylZY6jt
rSdnpo7uDXuPYiXb8Z7OGlyUZ0PU0M8j+CtnrU4Zs8+DhFiiN94qa4ppVwz9u9MNw27w7O5Asx+E
WFBbR7eACi+S+n3iiNnpI5kUqeP2Yu2iLT4axfQBWc09UVOc1ci5oOJR29LQH+qE0Iai8SidKT8x
eI+7fY9U4DudzJJtlZ0jijNMl8cKoYyutkHHABOrOYKlG9vbWG7cvTdVlJ+hx+trZl35qZKddmZd
tlQ+/TSsenc+Y7xvLFbmZlqusmrs/qDRK3e+p0hAqGJCtIUjpzdlGT+dONO/EfDx6priY6gGaz+A
YmWgxG39MuTZOKw9KZMQlVH5XYih3FO7+g+2qNxnEUB8MRzRbssmx+Xam+gIkmq8K+wGWGjy059R
HTtLYif4Reqgo8mUn28J34oOXIzlWbRqYpi/AMVWwf2UDGco7/oKJwn3BjCxw9zWTm78PM4eg14a
W9cbcnMlpjZ4kkHXqn0mZXoi38e+52fh0Z8RquSm7ruGQmtdIiihmHCdo8YUfnEEJKdt5QQT5eVk
GIfWlsZOAbyH2WCnj2RVNGeA8jpUTfOeAmJsmgbuew+Uua6bQL83XaU/dBWojta0xV0L9HIE+W/Y
IhwjFqOwFw6b+ZTBqV51Mn43JOwNAlHSjQ3ZxAXPXZFzEKMKxQ3FLBWSBtpI8q6KLRALKRUO2DmN
VwJWi+pw29cZ0CjaNXlIs5raM/Pnp6yqip+G22rvJXl4lHVFcAPTLn22aLaLdUKNtM4MOoRSRuN+
QLL2FtUqJVlYlh8Bw9XT6DTydk7BoZnco0PvbIUiviyalUI9N62BYPQQqMrNV8TwtbuxgCRfp9EJ
VJPaj075pQEKPRUTw0m+DpKLNL/ozo5wID5EGfnk6XiUNix6rcGLy/TSu9FR9cdUolHNY7d4K83E
odimbhDNiPogHaG8W+wVz1frKSBMow2keeOqpMYXvOcG6/OTQy/1ipawO+qaVW6o0r0fjeaT1ZlH
zlkmGfJPLe2+o1nPSUZLzCU6g3yFMtEDFAQx4RAOD9xMliZWdZGiCsDa51FB4zt3VF27MtL8gzv6
/m07pDOnpQmxoWjnG9Pv2lWd5nikelZ7Y+IHiz7BhmafGS7G12WwUV35UwewJd3M1jE+Modow0hF
bYKxitEbzn7yYhR+fsx0DMuidna2/uzJMNZqgdhStzbjLN7a1EsYRnT1TcwhRlhZXfab3uz5Di0Z
vBSmBLtK4YZrbL/+aIjMCEGYgXvmSa/vZyb/z8L0tCdIhzQyjVb7JJkm9nYi0uBOOpW81ZPW3vmR
qId3wsHnTWQ2XKIeoV9FT7VXW3p/tJOqSR7FUDjbOZbNJi66V5Xq/s5NPZOAv+QXCYL9Sz4V2Xeo
OcGmi22g0MI3155w04M3Flqo0XaTnhHVjK+9YdjY3pIxMxPWFc6uNh4T21cijDE6fXZEHTCpvcgB
Okvn7jNT8iv2hWTVPgadxzhgkBBRgU9yO7iBE+b2Z+TR8MtjORDJwayah3dSkUa7NhBBeR4v5Do9
hidxP4q50be1lH4BN9TXiQhImliGCTavVTjOgLh7AbE9oOUhynLT2yl8t4EeKX8eQHLglV9II/M4
RdpNurB/iXnKMn+LEntZ8F2iDP0Zw9zqxcDiHcW31mrlSzM5itCW1G7csJx0v34tRqXddtKmpW4C
wXi+DSoQlZbh9PQCeAIcYKVO1ez0YQ4OM6LdeJdafeLeaU0SWMdIgLkcvCzLf5m8o7DtmPVvqtZJ
9ZvYmnhnQdksE1VWirkzmfmV5+sAPvUFIxlRNwgJF2YoyBGsWSCmPoOne1ws2wnvS9IYy4QJ/sad
1g08zXXmfx2vevHk0mAk2aTdDXg4wR6YrLhEbFVJi/O8KUtrGxsKWITbu38PZr+NblLivfgqLyBM
7ndkyU2+0dS85DKf/oez89qtG9m67hMRKKYiebtzUJaD7Bui7W4z58yn/wdZ/oAjCZCA/8bo06dt
b20Wq1atNeeYL3VBuf5nXNtH8yreH1NsuX8bJKMdUshpNQKAm55T1TrJbGIZdGKczIvnVr28N/uC
hq+XBLTx0spA9r7N4O5gAmpjqV3lgG3wuZyFU9+4ejnuRx+TiX0QWCfyr3ZFOtkZha4Z7xonQhxR
cwdCtLA+IvXUWwiLfrspGXlliwuVTlO6Dq+Rq9Kci2Ix/dOPYxHfLXPP8RpR18yk1DYd/6XRS3pF
GuGx1X9ZSN+opIIem5uRWlA7gZMmSQI/EOI2Lw7505QMs8Ddbr/oU7dIMFIa3f4nMKUVGvi6f+rY
XMPRHpk2aDjvrZxHL8lmo2n4d4osAg6x24CQp/7o9SVzEvzYPtkQ9NrdG6hGYrjlSG9+R05Vzack
jjKHrqJtlhc/txMa1ZTMgtGVR9sRIWuKoOO+jgJfnGo2ofA4YKBvPvsh3jWBbViMKL8tIWmbvmsC
dxhqM8AFPfVEgThBdLX7NMqxbK4sRSDVNgoKYp5QQJ91prP/aaPFCK9uR5JU3UCkeEMpHHZJ59gE
ZGUsGHpp3dAd5pkVRG6OqRGH+bHmx3ytD3VRg4D9w8EJgENCgH1LTqk9Z8pw2Mi/0vhZ4Nr5boHY
PqDTJk4NJqGd35InWATXeE5j9xJWzjjc9sLryGKqcHnR9Uxne8/4+UuJ2zEPNl7lJ9rBof4v7q2q
1eZvKY+Rc2h1MAhyVL92TI3zn8mUER4YzlxEBkbZxRU7JJQEpElLSiTWUcf8zYDXLP8LXKHRCVpl
Ax9/Be9UbxgvPFRPurPI5Olyv1Fi6X3jlNqQ5xdPTiY3QTNJL7AQ4i+N0If0q2NhdLcG8q32s5dH
0QnXfKDfcYfGA2KUcZT/VR2WOh37J6Rew73qt3/8OV/7jHhSjon5gQYuwjfEb2/fEZ4eibdpmF9I
+1n8Pfba09fj2ov2kQGpnVz0NJ/u27piN/3/kEcvHwEiCwx+F50pTqd3iyXWBZycIj9z73Tcr0Kj
RANvMU8cl2uHmUui1z/lFrc0Spu16x1hWrVO4Vzqxr9RFJjfyOphS0uxB7gvmQwGqwTwrQMPuHIB
Jr+58qJZHBPURc0txCTHJD9oUaYrgUlFa3ayth9/tYsq5tX2gzXQYwamL8h/mPeL2vB/5Jx5YgCO
4+J6rpjzgGmI2t7hZjXU8tIQPzF89XuP+cTHf+kbCT/fpqsLz0TExGvH1Mh6MzQKzDi0bFpItNs0
w/5nINmr/KEZ/SKWM/WQub4stHPWFbLYTyHM+UPTcitFojLYZzDfpIc23kQCLaZxbuWd0e9QWZjD
tTDN1LrV/Fz/zEz5VnYJqsfmbSHxQ+Bjc403X5QjM9KYiySALDDhWVcy0Vh6Vbd3nVAwlBR5tqvS
luM+m5PwIUqYtnzytIABvX1ei1cKuQqfQNftd99c4lDCmKMuznbMROeqy8DzSBJv2wb3Cc2hpxpR
unxp8lwwg9ArJlMXZW9Q+kM1ZYvp4yNVVMqwMuo9nvMqWFSnngbXEy0gMglgA38HGQSiVdGtnbsh
jOD1v43XAoNWDZMjti5ZHeAWcTknX4dVrgYrdV1Sc5Dqy99A/0qKM/6pHOUpEWyLnqotH0xPk8Yz
S8bRjmQeJMVvJqbDA19CZzwwtqr9vfqcQTly/AZuS4WmY1lhnmNmkNkASqBtIFVVfB8t2Y3olqqy
uGZGZHVfp5Em7V7NYihMqCtwteTxHyZwtGEZDFuZfcGw4Q7YmUXiM2ENGvuB4Dwt/Scd6ERv4y5s
wlutwduipi+BjUf/qZRhMDC+XwKmQCHoxzKiHz1t8yxzioNI+jm5bXCAa1uobmQcYI7OmuLYSpsC
WZXYBqeecV92uBX3ce8zsvOIxtOR0BDz9cCyMmr4OsuYqiYAZ/waBBAXMfvXBcAM5VbVR82zX5T8
U/OqngB2i3Vz4/UyHo8FFcvErJ1uGz9sZEf8PrV5Ts1AEaflgWbvB5kl8oV3ns44DHVedzWWasnI
tF9UHatmjFxXKJi1dUtwu4CytBV2NB3o9AuQqetkNx8mXmOKDf4c9XuVwFSVh5jMKQ/xcvL4CLZm
oahHSe4Pe6XSi47OyHJBXeDXL15BasIho20lxd70g7Y4A5zUyxOt62WwuI7UlnSy+M8wdoF2TNw5
NPZ6I7P4TxuUImZt8tPv1PWhqjAPNdsZmgtZE2KwqicRpmm0dyzEA7chsHEfooARe8fZyyznGIEJ
SK6U4Xl3wY3aNc96xj3vizvKfPwxlHNibyFpYP3PKgvTiIh989lPgbifU6hWZ1qc3iMjHluOG/Wg
gxF4x4GLuuacTJ/1t4wzOIlv6hpfza0ZO7X5zUyg4rl7HlgX3oZeY3bnpEV6CkCmnKr4j6T6sF9y
fTSGczL3Mr8NhexozSnN7pzHvPeLGcq5D8LIR2yVo2LY6U7ptXuDFEjjxAoY65NfOV11BAikkbAY
5d505CKfI/Qax6g+0WQP+md1NZAOAlgEG80yci7ChNG4nYIJOIn1XVTFcRI2i0Y/xKvbP818pqzl
tK5KZhJqHBuGQ87mDVOo/Y4miFeBJFbYf58Ud6sR+tW5thzY9sJ1lngRIU6/Ptco50s3GizzTOHm
/XI7K8YQHDvtqTBbZ8uIHre9KXt+bSq7EueceNOX2MzrdE8aSd8d0E4N+hFWVvTAWJAGZRGwvL7m
WA3H3ViN8MkWwlB2mUzem6dca/3kSWt0ompmpuzpsdLQo92bi5NsB7eGbpDT695vq8pb52jWbRP+
oBdSIsYDcsQIoRjaft6kVWbHO5lLCyZh5+n+VktSSBgVo1dpbno7a8RdGEYy3Jd+5SZPJMON1TZg
OefnEuknQ9XRGOWFMPax3C711CaoA5KzEBj1OrOWQt6ldVzK48dn+rsrAE4rgjF0vGOcWs7bAikL
FkGs7O1zMWrjj0jMyYCgS4e/UXKnm486O83SThjb5hPxvv2uPPR0dDWANBdyHjXiogL/nxrGNchF
m7CkntVj5d2vjE01+b+ROffjhitJ+Ytw1yhigkTthvkuePJNmrF0y4nhZSiOqXNfMpU6grsb9G3R
F1QUxfIv2igsrIein51uT2AhSaMyS+WOtRXmmxrGRXxjjqGJ7J8Mn+jSWE5qR9sOuKK+zYZ+KG6D
kHjAp1hD8SELx2w3DsLDese70T4HdEK4tTP2mrYOdmuqPqt77P3K+6dNGhGdjX6yD2PNzJYQdoN5
s4bkK6XrXSBFjMXgt3v2i+yLzAkU3WIhIs6znroMp11oV7eDz8Z1geTub3E+II61ZhnVW1JM/W7H
TN4qqEaT/pebet3Zqcv6E7cQXqW39QpQUADQrIjl8Kfke/1s4EcEWtCm4SWOejQZ5GVhuWXPQYxJ
NvUEn4h0WntbknEi9tBL2+qOLxztI72ddNxOVmXelwRk8wWH+ixQwnFn3EtQIABl9My3T4ZX2vrO
85l0oSKY761l373ELPr4iFwIKFxejaL4DhLQu6PzhgZ2oDaiTUqBRW09eAINbK3X32nMEiG+kTzb
5Jhaafp1atjBLkbudeWNafRfURoFP2zYEKBDY0xk3yFmsF4gdjnDTSvD6Wr1GXuKx+xe33IYN+A1
yQHtT7k3j8PGYtTx3A6u59Eer2p3h2OaHycUGI+PdsgHjNtaZjvPInrlAFOZDwh4y8hhliB82VaW
qEh0pSeaBlo4HALTd0wukFYj7W9BN8w+zTgfpbAeV5N2DvW8h0mCaivfQqAWBvkarB4/ieZ2PwTA
z641rpXuMFSiKnZGxvtxLiKv3UxzUcS7VEtjGy5/yKvSaVUbP2PuXSTWQx/Cy5o0hoZp1U9Q6kY3
/O0aWXyXT/6UPtTYXEjKFgRZANdIEXNHfvqoeyElcWXWFjUJ/QyGLejH/01kvaiDJsQMJ41/O++E
QNr3qKMYAHa4ysARaboRiJIYeh5MF6c+Z+aYBrdKW56Duq5upGnXf+X1gaRYv58kuZu/cFd2sPgw
pG+E75V/TCMJtH3aceae2zrWTlRvsr1vnIw8XaeTw6FofJJVLS0vprPs0+FBQ4LWb6NezgFjO7cf
Dj65rcPJn9gSb4sxWuQyIxGsQqumr22uBewtRjdNn9T/3HrfvU/kIOJr52DDS+y8RXM2eE37MY+Y
3Kzq6VnX4/ymKtI4vunGBOWyl5KJ/X/GOUXaq7nRz98QxCwMNZOREgAyMy+K23EyRPetom+EzScw
iEBFbgN9+TF3XJyVG3aLcbrrMholKVwPk5Yw+oNF7T6vFDLbaUp5TodAJ+8mpgV/bFZehar9tUyC
9fJW4T6IYubaVKCOG1kbs0+D/r8yZCr7BMnS7H4UvdX1l6zPljRHwpJpY/Up6n/hQlogfXNAuBn4
wYDVTWYZ0k0bVBngMXPWJn5YmzHUmdsq5URaZsun7ZDPWQ860J/qd22ForsVdC2Qv/tmyha5evok
wmp2IDzCbfMz4f5By0YWEYp+9jP0eXVtuT8TSD+sqplb2VF5MZRHQfkVynyQC9sz72iqdREbwTXl
nWn+z2yxdn1Cx0V0HHhwwvYutE8ku26hlV9sT4LDz1gEyFXp/mpnEJEh2empj8sCXx/lHmZsRIyq
ezQR6RnvkqaZ4kVizN+i9Qgzj8qboVwuloJPKPO/Yj6oT03tw3MvEty9BVe6RZWLM9Yy7ozS0dq9
kierh2XaXMOibVlLniiHRFOeGzpz6RZVuDGeuE7SwtooYmBCRGrzAxZfmk2bSc94U5ZYbn7eJALh
BIoYYRdXlpWxNMZ0cB8imrbuQVfuTwX2o7tO86FpaowtDDq9kMTxGUvZf2bp0xTL50mHnOyaBtKP
1JnTfNwIe5ijcZvXBN1/4//XExZUNzRAoxaLgrfiUzLH4ZtMHJ9v3jNjhiObTiAVuG8t0ufvzXDw
cPOutE1ZM6W5CFiuxb7ELCqPAFQTXA6R3S1OgMUXACIvlwxmNoiOl/81cUdH1L525qY6Rg2ttqxy
ddosJRv/kXKI5ghhrW2dDo17DoKM+x2lXs29hsglkpAP5L8yhdlQP3u4MxotaUjdI4PX2So84mzP
FX+xRu8bt2wri+yHi5DIeNRIvSb7XX2PGq5T/quU5Hg+eVcaPOu2HPmGyCAJxWUJcrRvle3SSh0X
EbvoJjSLeBvYIhjJLL9jwp/p9pwhBsGZNU7n+GJVHXqRUCuRgGTS0KpDhoHGOeodotfTGLSutmk1
p0pv1fJXmCTpZQ7GApCqWvCvkXXW/MQL06ZH2bSTs7GKqPT2TaRNzeOAyRqNQ8xd7VzoLXndG437
dfGrCLI6PmpF3TORNoxu8TeY0cynnZJyQaZSW1v1syey4Skxgyi7Ddm4GUctdiJlLUqaTv+WCC1y
fvlhBfZiIGvKeOIm4nBjCiyELsdyyEdtM6EfN69Vwvu5nUxtNqmdnanfc8doAxy/VTSfulX23rZT
4e4oW7roHNgLqmfw4bNcqzCZukcSNegtFKNgiEpTayb+iwv4gQAL0ziod6Hx7HyZ9ibQOUyJDKEj
Bg5lmlmhXmI3WDZZbyx/yBWYoowTMIL49NhEu2rr1RRjd38NFbQRkNrH+sxry0hAD54bt+u7UxgD
aC43cWmTIpTTaZkfYCXDeKQaGSFi0pEpX6TtxvoXph7UZ+rPK5yaQwBcpe/+qM2px/aoAal8RFuq
z0cUUcj7lWU+7y2eR5b2tPmWpdKOZ4WFMN2ghDhCOHm2TfzUKPkrkVL8oB8IwNVru9n/6pGj2OLM
CILbKnPbnYyiGAyx7iXTToFwS2kyiW9SZGHM9S2p7RRuZ/lB528YJL3ilNO20y8i8uF8UNwa7Q2M
aZ5HkdZJsIPdGheskan/zhbheue/7+zq9VT/rCwKYdLoBjk5xph95dlU/sEwAM/ug3Ig9lJttGmb
zH9GGi/lTitoGe2ZemjdlXYtY9UELxXpCAma0mvBBJZABlSeHEhiQpoAmqGmNaU6uS75CrxndIUW
G0k8COwtaW/gSnUDp2enKwZUSqCYFxLHXBgLqDcoDMncrPf7q1025vKaruxN8tv5Qp3Y4XfH1syh
CIlhOSBBDOM3EXOM01vPkepd4pWAId0BZOfEl59dTYE59tnNgR3fVut2PxJoW9yrl7gtBs0FLe20
8jSVM+eml7IzXvqyMkHoe0ZRA7dZRlX+d0auHNEKXokOcOaH6ESGHQspuk/fsLDd7qFd8bIYHa30
VtIAN9s9+ZQs6cyNJN+ETTiA9lyWDIqOcamNVblR25trDx6veuU2LceWv9rc1i8HD91iLXQEH07Z
OYcJsv2XHgA+ohst5Zj7+J77BrhP75ruP61gKAh4cdFOvLltko+M94tEdy7+FB90oIif2VtZkoWI
7PSa/d1Ef9rdMxsfuz+UIUyBqzEPKa7sMmNBMOUiz3Gc3Ibp4wptUAPjjz+n87ZTjAVWGOR5AWuX
HnlPbxrWoi7o7Euzvih274jgBRMsVq/uyI5f4gLW7fqxCEx4P7A3O1olTBxwDcDaOLldjOdHFQWY
XRhmJRBy6x2tWuKxnMSb450GACLcEzbFbkC3KByOrSbS6RDMRmucCogKtBNFa+ZHPJr+wYylSI4w
jydgi0Ug3EshuFDzRi+evx7hWrgrpCj8YRM0XVEdRJMntFM7ydmRjjED+QQ60dc4K32WdJVasbdD
+tcfm9Lt8qc4oHLGZGJx/4rwz4z7tE88VtUU0bff17ikS7yzju9dOsnd7ZsCaS1XJ0y5Cr+tytqJ
Finm2HUXKVt/2VSVgWHMOuoChZ/NdVezdp0OXgibEiGkxGPKqjoaouG4RQrNqTyuDNy//C2Hbf7Y
RQXrtVrrC5fKDy7X6p9MufvE24ikoHGLJbH7LL1Ff3sP9wRDNJzjElLfAhF8445eSgFhSr+6qCbt
gm3MbtoSei6dEjm6h0Kr/PaA0rGNNsWI4nzDidiGBzodeXssXCSJO+X6+HidroHp/9up8+jMeOR6
8dfDc/Le3mg6pOpZNmbmBZ0cSmZi9CCrqoJwRR9sA9zG7qkznS7cwjprIZ6RHv5PWUpeJmVkVmWX
2RqlvkD5reqbhfjBPQiRaxt1PI9U/uB/BnvyLkHJ/YcmDdrkh2KZzAGzLFl+CCTFePXCTp++48JB
JZzAzGcJlQkhr8+Gq0VffIwu5kYZi0HXs3Zip6dh2iOliI4Q9IPsJhH4R7jt+DQJHpnmIRqPUBPG
XC+XgxX/Er8CPFlUSvhP/w0bMNPopXOR3muAO565Ono/Ktnp7a5BPXaZyIq40708L/7oGLyDTUNt
+Rsr2hzss2rmewhXjL7EAz7B3sJgeASFXt/YSTfR+JzwKZ+Kwfamn1zs5pePHyGD/je3UsZ4yBfY
FIVjM5p6O89rzaps5rqE7GpoXAdwGHICqfuYMmsn9UJNA5A057+Z7JTBQe+Y2N3HBbHm98GEz+GI
ujPPzjbM4z9a0gc2wGDPn/fskMX0EMU+Kp0NmA6Qs6WRNt/TOBttMOCSlC8rwnlx4wmZO8SWO3gA
tMxuiFLrLKDCjIqW11aL7WEfD/wcG8Spln/Py2ZSKXWeCG78gFyLrYdqytgyy2qKUz8WubsJ3YW2
p0qev1gSra3LX1Tj2XShLzWfBPs9IJC0gFpjpXPb72t7jq07kXLKA4aLFyCU2kDUVSzqKz2CZszg
+Ity1Hd5aIJ8hLV9jxBqAqiZtB5yNJcJ0EY1QAbk/OE286PsX5YXOlV7xcSDbhwRbtraHG790KIZ
pIFvwXVa153cq2sg4rT5H1YT5ksL5B2ZEa6ss11v4Jj4BeaC8iLCZ84VyV8cXkEz8M/Bsr3/BcQ1
tV/9ic0hte9kP8ozIZuUVimouEentrr8mK6mfizGzLb4YMFcbGDuD+OGW8vyZGHA+yQ0iGYg0X1J
hRZ4oPUDhKidbqTipXcCItlCWNGQ6agqztpcG/HRDe2QrqDO3eXGX0kdHy/cJU7l1fSbnjUoRUnQ
H5gwivhlXf9P5zhMdRBgpeVeBFQL2h5Jxfs8r7c6xSnw19vV0GY5HlPbX322o2f9LNq8yH51uf1L
OZ3VAG7y+Wa3nb/AlkN/uokty/G3zBkjczdOfXITRU3yHHfZ7G/pMerjDjvycipgab8P2Sz0vZtx
v9jqXomFvckiY6vcoY3TLHU2ElR5rHRbnKupKKe70nfsn7qdehAMewJ+LrTkdBxYWjV7u4+/q/df
FbnB1BFkvulgKN03B0jGD+WTxKJdaB3jgVR2Rjpf03hb+UN8V8sWpcJUxh2TRmwjn2KD3uAcXUiv
S0nDfAHdKOjSd4DJupykKJv0WgVGNp4nx6temsAlOticmLXcx0E6mFvdNS3a9vQLyPWAgNufzLiH
zNCp85dEimSfOpEIj03mjBhWlK82tQiRK6rS0HetXtMvVIVnkM56d2tMTA03bd0lwYkFbRnceOzh
G+xqPT2mq+FdGcg//sqtd4c2lQ9qE5ALTFr5Y9+UmlAeBpjDRnQZLKJDH0vd1pJrlg1hd6jY+t1H
G/f1I5ZiXkx48t24Z0oqxxeR4YuB5eF4cPgX+l274wpe4z6uDOI6ZjOkjTwnXTE/qj8ZHaDMboOh
IuqhW8EigW2nHGHMerD1b+uRNui3uUfmQ75nwdc5WZHh7bSpnHZBbxs/VFvQpEnSHRJPR4Wf5nbt
nC3Rm7eEbwf6reGxLBuGQmalPVeRNsIQYYUjrg00lrUCQZhpIXSmHKP9Wd3+Vu7FF+iZ6A+QERE0
TU38+l1Hi+LqhagRLa9+Ua2K2Bw2ygysxvFxF+gLY7Ec/C1o14XTpB6riHivP2ETvdWToLuyBBNK
QYfOWhK8Xn+cga0Nx/FUYLuHQ3iXGOMcnwevXoD1lf6vF2Ck3QYLZ/TUYcKEPF+iunj6eIWZywp6
VXyxwCQOMY93GwrKW/mPGQioE5rfXFReiVfRCzwHJAuBkI1D0lyxq5T+DqRQM120ckKxhG26xBbQ
d6G2j3rm6Ns2o7TAzGBxk1hiPk2mIEs5FeLrpVHQRfoysenb6KAqIh3HGaOoqK2OXdVNHDt16ezy
bNaLw1zQjjnauBtSPJMJd1QFWZmWXkiwEidVXfHxF/F+ULXkwiN/4nK3hMXxjbx+Hkw1Rw9Z+HDp
2FpvBsLWrIdyrhzo6Now4ZUz+tRllhoSo30CLN12yELrgH6OR06M8QzZszROKqOI2Czs+Jss9n54
tjb03yyD5sVXLkPWeGDmLO7RZeYR9odhbk746hP9yhQa8ADeY/jCiovD21Z3N4htPTBEQw4jGZ9d
tbAIFGjHGggP3Fa1n3rXDujBS8ssTeyxKeMvpkkUi20wxVX/GyKfrC7S1focCm8OuJy2XMX5by5C
Q+kGB7ewg/yrX5RRxx8+ZfkmCkU+/duWYjTwRfuT5nJ7TSgyIFho5pnRPSUVNBd6nk5lw8pRcpRm
NGmEq1ZCk/lUckh/4n/cyJk45tbNN1nbHdIuq5mj3a4j9ElRUW0FaoZsJ1F8TseQNBR+zrQrcryf
OWLKk2bZUb5PgoouTc/nEtj+Y8xPnqElF3csJ+1AVcTqBVLZe9fIcWaMfKpJrYVj5lAAZj5FklLJ
mrxOuEYaq5LfAMwMwZ0BQhi8jy61aOsSTQTXU2DNvfrckRb/Dj6DPQwE30Kxipt9qxWk7u37Rq+s
m8imlUuwTDTVBO9o6amPraaGkAH5FBF03hpEj9HMBegqmWES/5QeEgcl+ZkWlgZYdyVIwYDN591M
is+jl8VZe4xmaRaXEjYQzSLYII9TVefxCSVXTjk/NSF1awxz7JI0rWce1bDEoLEOHgEninVKRRR/
nQZ9TneqmTTY3Uy6Uj2MuP/8ZshvC2PM058RsdzRM33CzNzkGSCxe0Q4/SeyP+NdDQFY0QYYv9wQ
Fhbum3eMmXjKhuj1Fz/IuaunRVM92iiev2hiSQjTSmuITmPSptqP1s2ZSPqoIkeeSUkakxwmjve4
JDtnB5lD77AhYeagGR6wOFFdNeWOTnCSPYiRCFTkKm5/Vqd7aYh+2rolwdt+nMtHC8HhoXGNIjsW
/HVfIQJwpNUuHNfnj/cV692pYzrcbxl9WwZ1kyvfHOG1MZidk/j6ZdDIzjnPbVIWR3ZZ5qIVN4bv
xEQOwuZeM8JFGqasxthpGPNtXQ4dro1irt2BztYCJ2NBdzcZHXyxCc086Q7NpAUXGFXuvC9t12XG
jxXspyrikX0vXZW1A1lLg2qsAZ9JUo4Nk8Q9zqzbvxzLvKd0uPWmgF9nAbHrXuKU/kJrySyIh5kI
ft3oLd2fPaL5Bq8kuI+fWhpO/r8sO2d+mYahXfI1s+KzMO53AFTPdBZlOa8e9Q+i22Ua+j/1OSpb
7lkaitSkdhGbAVwlgy7DhEwEgyyQONnmSDE6wkfg3/QyKL4GCJn0X07KG/RHuSU+fqLvFzF3UTop
ho7Ihfr9rdDFHEKrGTPfwuW21JWNxe3g1+RMbniJEP6g4YtjP7zGgAuiR9UlV5Q2NSFVyYHlioIT
IzOim9Iq2odYjG3wBDeoCa5FO4XmlwC8bQGbusi6fefLqTtA6G/KH9aoV87XIovnnntTYhZISQYt
uCG1ykn3gzMwe0b2MhafFFCv8eKU37QQgWQud3xvSXt4o+Qg/gJ5CRX6BeEtSmenRY5yOxsZUj1F
D/n4e16f7avSxEJxzEbBU7d0iOZvNgtgfW1DC94jTMYcaSd7Y9N7Dykb92PhonIgbi0YHHo5xT+h
gcRlS9PaYGuhfLN/DX1JdU77huTDI3mIRDZ+/PGMt4N4msCsgmVZUsLRVHuzNIdWT4fEdb2LmUXm
nvGFyK/uYDjJxtGapj5Ma7+pNRwcKMj3hruaTD9nk0rZommufdu7CazAM26yqCrHM0waPzw3uaOL
YIMh2JR78ATsz15eggyCabBg82CGzfPNbJiDdQgQejhfpsQHsPDxz/Zum7bZoY1FXLBYOsy3HTlT
ZhwbDmpq5a4JVwDOSFUMrW7uXO2e9wzdXzrno70vpkHrbj7+AGta+atnT7wpY2/bokC2JbE0r9/7
qm7DlltKdR2mOvuXeW48Pkf44+IdaSvVixJcum4lq6NcA7aYKs7yho0z6G/HNWhtEJqFdtlPq/gs
AE4Cb1jLD3WvJ2+A/dakBCeqzy3YHlGFcLkay1JYOLV5QOc2YkZyBi9YpV81fu+xnoQx3fl9T10e
i5e5tAfkQqVGwOjZH9q43eKzycctLUqq37qCCfdMP8wqm42hB0kbbekgUdE2ZZd7V9cc0YgZ5hSY
Bx0FScKkNhjJSehNG6cDo/Bz5AeVe7STKZUdauwhHHZq+NHEI5oBqjuaAlBYl9ZaayF1iWBZeVtq
Aru5defJ/C/zs8jbm2aXk+GXUkftoXpChFWNKCLEIUwybaFMH/hBacCvQ6Biba2aJffsa03cY/4j
xnOPkErlI4iYpciLz6+MpfMZOC2nVHflcknV1Hl9OJ8WeOV3p7dqb4NoBhW1OQlUJrg3+ukXY7q6
JFOwluH3jsn6S9/5Q3FQU6fa1UJtCyhaVFcZtJ4GRWCIBXzWdu7CJ/U5/aakRzWbMo2Po6ax8ZX9
1IynaIyXAXgzIZ3KoayMRXcv68loPnlF3sHHPUn6wNKwXjwBBEu92Z1iICqTVdjpNQhHruZpaDA9
VUl8Msi9ZMmS1SNAfiXWLwytJQcXFFG9+0/duIvZ4z5u4ef+PVSZ1I9/ZQLrPDVpdebbjETYAbeq
sBbGArayENJC5Shr4V/VKCELQ0pwYwUeffwSvtsFFv2sgU/DE7R7APW/fgdD0aMUAQR5bXM91LDG
Wulj2BPlcYwENKaXgJmifnKyzkTlvMK0Pv773x8AvAzs/zb3dpvd6O1XzO2cU3ayRtoyFoppJ/TR
ntscBT7v3EIdb+Ksg6TIRTRlnFYBeG9C27svZy1MHt0FB3wh9olaoVsxzJ98vOUJv9qj2B+ZW0id
VpRAsP7mAPD9GiARKJtLv8501GVVJWEImLnFc4vx9oxjMB520ChRMGa2iO9Uylxo6wDs/NnKLhka
vfHGtMmP209TNDN8E3kMPcCg336Z1m6LetYf/wDv/G+es4QmkQxPSg74y7f9tHEa3UFDX341AztN
d42hBbw5xpLSm6VCHw51mTrmXbnOorHRTS39bWuAaOYWafOvAj0GadIjyLBT/5IlRW0//O2brfo7
DUeC9qzUYFyY05kUiJY4u0hz2/qIAYORCHkJbGVaYdrXBl2HRTdhjuL7rK60BQi/jMtmgmhxgjaj
8+vjr2BZwq8eIRMB1wNAzthJx579pjg3sghhuFvb15i2GGTAvEzzvW4sGtWNmsx2vZZZjzhP9OaT
curd8mHuZRFhwje/3CzfLp+OtMJqrh2NiNfCGv5AqU7bexq5gvapycJutk0ycspGQWTluzDl14YA
yTmyPzls319RaFPiaeItNyhrKWxfv+hxqedFW1NBalCR6rs8dPLgBupVkRxo/ghY5pnt9j9ti3X6
2MfcpeERINXQ/q3yCqnNYqAlwkTWif2okYlGo3I9RZSiJE25vC1OxziatsYIU+CUC0D7qMRYGrIo
7B9+i41bGLYGWYTWONENPbepfZRadHKzvgyNCzJtkDCFozkJJmHXiw+NVUwvJBQIQmggUOKGr7uH
Xgewd25tTeQ7bcSMd8uGyaXOnmIOPeUi/ngJvR+sLqNLyl6yQLnQsppef3ulC9NVtrN3lZW37NBR
2mU3MCfr5KyPMiKpt/OeGoyo+s6gl/+lasmE3+Y0JIqbPrNyIEfokOXmk4/1rlqnMMVP7Eqmqmtr
8/XHSibbpm3o+FdTc/DGNFT1xRbNJ0HtEwNmxBFp3LW/DPhEwWOulZJg4Lg0v5jdyPtvBU6HP8zx
E6e95clk1gFxMTupW9kt9o+PP+z7ETAfVeg4+xZwt06D9vWH7aOxR6GTVDeDP3bxNxBIvYPWrs/p
7VPjJ/JGDXvtVWmnblOrOIqKgc1DroHWaptR6Oi/Wpy1XFHDRf1vmz9h3KKZejwd4VU6NYL/MEnv
SEmv620PVcA/dWE0DDvTC6p5QcD4FW4R2rIIIWk1bYtGv6g+VlghxT3bfLrypjHBNB+QoIXgFYai
n/4bRJVwccfI919OalO3mw0XzKzwa//GBH9T7Ti1KKAQ6bQDYt4AKhHjpKg9T8ksp+M8egLwEUNV
Wm7CGgYggQOoakNzwoTUgaxJD1LDiLY1vZzbJqdztO1jXsKNFYSauDVQLBvZxhBV093YA4ygLURV
6lKEs3TxI8hJn0ljzDdjYHrrPEHGRGQykZfGdvL6OTZRmOM50oyrelBx0cn4EtC96e4ttw8kCSuQ
IbYMNJfqFR4LzS1vSH/O4CzJmoD77G5FDN4GND2YgjOJ5HF6J6PGLh/ZgutnpRQnrpg3zUlEsrBs
vAbnLF6m8pfZUVZe1E0pW7saZhMFhNlzURkx69riHyW2VbH0cgjy+X7Oxv9H3XktR45sWfZXrtU7
qgGHNuvbZgMRWjCCIki+wMgkCa01vn5WVN3umVujuh/HLF8yqZIRDnc/5+y9NlqTBvmYeOwyIzD2
uUq36P/V+vrLds9LQ5ocxw1ma52LlfqXbQIARddJaWTu6WdI+RrOurpe5tZC6YrKUVU2Cr105fwn
4T0fA8U8tWY0hF5C1aGs/tRVA8ijUc4woSKxSLUkEOpk3FjGgX4SM8xJhUHj8hhHGmZaDWf5PEw1
r31hLYrXZAr/Ugx4ar08UNA5op0fwsNs1mInK3IH2S3MR4kXUwcL7P7xjP/LP+Umt//2r/z9F5NH
iAJR95e//ttTmfPnX+9f8x+f889f8W/H+FdTtuVP93/9rPV3efrIv9u/ftI/fWd++j/+d95H9/FP
f/GLLu7mS//dzNfvts+6P/4X5D/fP/M/+8G/ff/xXZ7m6vvvv/0qe2Kv+W5hXBa//eND26+//6bo
7Mz/8j9//3988P4L/P23Y1l07XfTfHT/yxd9f7Td339DUPU7zkddmBTiqsyQgodu/P73DwnYu8xi
Fbozdwzvb3+Da91F/Fjjd5Id6UuwnTIvNbjctyX+vz8+YnBhJduUKSrLUha//fv/7uHPu9Gfb9v/
Pg37L07ue+FjQq0A/HAv1zE7/OWRH6yxJes8nTysBmizhmp5i9Jp3WuZXLBxjvfG56hecuLjvics
bA+xtEy7Qk0k+tpj/2aEqdin5BMA89HC7RyL7EpDIPuHIfC/tP7+c4vrPHw3Xd98/+34UbV/W/XF
10fHm/r/w1pjafyfl9p/69uuiT/+aZ3xBX8uM8X8HZPWnZGrkMD5x3r5c5HZv+usK1IFWYGUgsa9
Z/+PNabZv6Mn4+SWybIzdAwp/7HINON3cOhM69X7tgc3Qf2vLDKKvfv2+D9u6ogtOVMUgww/9k/0
h3/NPUnCuIusBZEU04Ng1/a0A7PZn0bzNQgjcwWVd0eHYi2ra2zgdAG0ztemdxPvtIuu1nAzFLBP
tj73M+KIKH0ek9KX6hrCMMTH6GkWiDejSF8HaunaoBNdBZSca6cVmYKC3LX4qZ1VzVO0bstYzm80
1THKKKQxHjtWOGwRbTgife1avTyo9ifiGzRbTCUi4qG1qYGi0cZeGaZeYiEkmardfaCOnF0c4aO4
emtdAJu5hXaTFNK+7dnNcGLV+ZK4mbyco3FsvWBR1yIQtcs1wJ1NuE7NkaGCA6iZOMpkh/TyDWtx
5yRNikakQiKQuA2UQq0NXodZ2ogUtfuU9H6sB5j/3ukmO9G4U6r3rrOhalmvBk2WKoXi98ZTUVWo
0afbIPXCm1OhbkwbzVArgM4a7Q6A/XOd5aS/jc99qv1awFw4qU1Q0rITs+XFdmpjYOsOWStTzxCB
IanT3k6lDWo5zIj2qteAKYyiWVwKhY02XunyYmspphezVt3WejIRQ9UNv6duuX2uuFM5nZsEf0yh
5P06LYiLSMzoUifGqonkjaSaazpQB3l6p01hXzLkJC9lZdVPihRj/wnKl445nNR077ld+vJo3ZSu
gjxWvwmt2nUAasrmkaG3m3NrcJZwRLUVdSHpScDfgqbcZKXwTftzsaRj2hIgl00D+NnKb5dxRxfD
8tJZ3Q6wSAfgMC8NJVw95tBpExkOUxJdsbE8jloCZ7vux2+rugXwXPVp/gBh5YWB9YDM/YGJEZ66
CyE3jhRAuMsCDyRv6OV5Vbp5ZRI7aOYLJGaAdI32RCJr+zL1xfOcpRStOYPBuJyTVZ0EhdPJMk6o
kuaSivNXVT2zGFwd2BLW8lE5xkt2EUa1NwLimfOldDuL3mdinwJGTEEeem0fb/JEv1R28FKWvKRz
7aTpTgP+16bYMWwiUMp8GwBzM8IjVrDASFx85o4c4eVnrhlKvYPO/NkSTPHMr4T4nLLcp2Z+Rg5Y
AvnyLH2vi341D8P+bj2x7RbYqP0YZ7+W8N7gfBbVnk89Gmra+2LQPGN4X/JPu70gYd2p3LcZdPR2
5UVkGoTpnlrXmfqS/78y70ep+1QCYHH4tWFQXgLBv6s5WMkmcBtQckuIU0TC9lfHzzV812ZJbnNo
neRFQwZGCcL1erYVJ8JibZk71MbZAUaLU9vVU22El8rc4kJEDzcI4ueVDYAHRBsT2F5qPaKS0Dkg
IZk2Uiv9TLEZ77FaPChpc1Tr/gfI63ve9LB15uS1DBdzHaF2qwf1ZAv85r0UkwWT6PMvZalDus2V
dRmBZyC2g0Uns2/4hao8Rdow7JbJas/5YvcrqRokXn5p3BJ4CAqOuD6nsJsH0eqPCE2uqTUeU7tZ
E4sO0R3Q/EtmjqNCbrjmABN8AvfI50sOb1gVt9c0jFd6G+1Cud0MkXTsU9lrLKBrZvu+DAgSu3vL
VxefStZAB+r2zSw9ggdJXDN503JIiWHREZE7hKsCHTmqqlnx74JeTwMM6NahH9YfFH1OWJIaWA7i
XKg/NES9MUHH1Gv7coHSW/XDzVK70GfCF32NAcJCYFoSUOZmpp8wpbMvBxYMELMpKidf5PexT80D
JCVEhbT3/bjtOp+CwV63Bcu0tszeSVtd8toaYTtwQKxhzF0IuIJxXb/mwnqKlAYTgg08BNWS/IsI
N9W1y0xz26WefTLu/Lq+CbN+xXlBPFHw2uQ7qbGtax1/IVLjec6g+tYJbqqLSDYDD0c1OYXhSeY5
lncauVm9ve7UX2XjdiGPRsUOWe/nrNzm4fBuJJThgRVsEOwz3pfvoiqnYh64qB8x9sgoLADUzS4d
ECcd8fTOsltO2jEjuXQKsKmaSrSW59eW/UyY0hs+EM+sIfK2uZaudbIBUcGVpgNU/KoEJOGOzYEK
9VDlyTXSjUemzCSEyVmZ7avcOplV/N5OGPmifjpY/HpDkzlDw1Dm0Orc/WjGRjsho16wLpYWvuVx
TNBNQaFqefCMNe2xZn+thexGcviuJa0nUMuSmLrGkeyOtn22jYS+4rZtDm34GnT1u8Q8P6p3g2ri
CyFLkVHHoJg+PhAvMhsvlcJTPXRoS6WjPmVvsTltjfo5z5pXq5pnh11wT1c7c8ZQnf1CpmthBWXi
VEa2iuzOPBlVGLkaGq9oaFDDdcpIFTkcpDG9CH42Vvmqc/MQgW8F9D43T0U4rnENMuSJTplmMajh
XZ7tL21uVmEtPHo+lpPoGMUgiqz7Id4zjNj2RA2gN7+vWNOF+zhs7aJlxJcls0ew5BsA+yfmfJ9a
Vu2nhkkfahsvT4Sbs4KlxViBVBse+0JZRan1JaYUd1iofXWGfeuQifLrgYnkycc0IfBa542xwtYk
7QNJC5xCZ6nYBVW1uXCUvE3G3RpHCJ6ft4mjjdkr2tppO9Utz6KwJgdFeQLJBEr88FRPyRacc+cC
81zdqbuQBl5RHT9JSnBR6kVZge9ZRXVgO0Nczy4OoXhNQOMrs7uVwgmPJttljLevjGkVUBOo2KN6
kFdG/9IZw9ak+8V8pO4JsFgwdJI4HS+ln1rKviyLc59smQsnjjwKGcUEr049O0aR7kB1bLLUdAJt
3MfFmtsBwNx4yyHGwLcNVklmrpfc9owpPpeNwPEpfQ8q3FDb9Ow5vjDQe6zU/DJL/VkY01WKSn9S
g/xNha+Q9cZjWndvsvyT5+q6R3AP4BBbqRJ+YCRwUV5sETC5kzRusDuu065hRzhUMtc6ICzVcbDe
A+rp4UXhiQ4KzY1z8hR2+nwr7MKv5Rlm38Ze2GWVwp2jwZPsF3VOXWv8aEmk1ptpJdJTzBcSy+3y
dvLead4k609JptPBmzajEnFc5O/J/YLH2FncCBXyBH1TxjXMylBqWdO8EaMVOly196h/QI8Qzyj1
j8loGX7cRPigYSBZPEp9ug+18RDj8HDMZjgl0Rblw37KZq9gEHyaptoj1ffXH57DSda4yZQbpZNW
shqy61abKrMLl0A9r9YLBq7lxUgF17fps6jqzbjASG0GCVmu2MHJBIqTOSXpsCvdKJ9ByPqdVV+V
lnYVyyASlz4mHCf1FiVlt5V3Lb1fdSkeaKYTp5LDmG2QlmIFealD4hyMzg/uGD4VSFShjytSq1+0
odnGXJ1OEr7T3G0DhU46GyfwND5Ri5C2D6QtOcaM5gwb28R7kVilterkHoX1TtWPfY49V8/UHyNY
nsuRXwGNghtGvXm1EzXYGPNISZGIhxK8sjPkF71qPg1L7jz7DuE1Jmh+iQSaxX4nHcdfFOksGuXc
zel2LL/0svYCncIhj+78DXmkDpjcVk8e++W5ADyADAz4e7tVU9BeDPsds7SOctbulKZ56bRlE9vz
TY9GjM3imMXKnnPCHWn2JaVMf0n2YhEdRYm2GQo6oIV+P7W1cCuNAKyBKZlkmPkKmsgqihLBRiwq
v0qiPdphv9IQHdF/dOoGfknZkyS8bGwp9Sh0nmZecjz2XpuzqSRLcRig4XjwR8GsDt2zlU/cdSF7
+CO8F1pVMwGUugc756ONqQLGXv7F1bV5Mwr2/xSI2QmTrsbmMRTrJRWdGzCqLTwO3T90WlrjkilA
zIlU73Fwx5tQwEeuFJUBmapvsyT04i54zJgvP4DZKtyhbarnBucA1ukyH82zNE/pGV3t5BhKJa8Y
YIDW0Cvaqgz582odKAMfMSx4O/YKpjVX/5oXIyokdFll8ACRzm8GVTi4OqbVHGCRa9RqY/b6E0Pn
EwIECBYlYBG3AoCxaoizcHGOE/tQMAFnBAD2+g88nHSLoLMj/DODd8mwUftIjcPEmHAwkZ7nxFxW
YkzbbZZ2Fmajku1AM/2qLHepHVxNkiWcsqxOEURTtyiKBxyXqTsUX3Rx/azphIcmV/XrOJXcJCc/
Az4Kjpmw/VJ0BKZWRtoFk0B3jLm61aQHuKOZSGsgBO2hM7XCNVrI4W0cu3Xc2wej4yBrQjj4kyzt
9EF7Eui9wJ7jis6otPSi8MxJfAyiVVdl0dcbZOiSN9a0Y5fWyJEfNeqW+8+6UkjVIWrRnWVSc1o4
tLxJq6poFFQB565Ot7HZXFrZPudc/wBVAcQdvszljjRZesdoQi+olR+0k4diMc4mURjMrJkmAeAU
ObfHTpGo/srYcJexiM4TdhjC5Khxu463LVgKkOEgk1ZzowpX0eecmqh9rxrxOjbKVUWxO7fmoaxr
H5/ieWJl04z6qTV8z3K/GW3zp4hBLhTpdzPoTtwGH+AUNyL/Zdkv4ai8qEr72GTak87UZBfM0S/J
ND70pn0vQXGYUn+NVX57SRPnPAIt1SzGR8WUdZRjfyYbapNN3bYVlaeWtRPHXzlFPLF2ZEdY+PRg
YKiGg6nGcGaAmyX5w7h9qKb75dbIeohnD5hGPWd0FaqTJKGGbZeLqKZoo2bvldJDg5eHEupGdy5N
0MeMeTMPhhmJtm10MhExOPpsuTmqf4QzDgTUl5YjBMPAU3svCeP+M5oAzpnFUrHRGJNndSQhTFCK
w/CGjuSxLO4Q/PZUiRTI610wv3wNiIhVDl4XfQB8HVQfdcdxPRElmM6YJcHoy8g2qMqvWTWsulQj
XNOcP5iz78wmGA6mFf7EXHOUMNmDl3ko5OHL7oza452l6DdDnsfiFWr3SjaiCtOWyqW98IvGem0w
hWE6tTqH3BM02yZDLEGol/IeJ90DppyNvhiOej9IhFH7mQVuG5kfxSp+JrHsgFqvGzyRCIB3BUJ2
eewdOeufke1IToSIOJjM1cAsL1VGVKiIvWIiM7hKokOendSYN0BtHTOkP9Sr4ka06ujEGu0NpaXM
rpxm7LYRxixyQD9QPW9yq90x5H62umrbq7Q04FrD7u1xjM92dgi5os730Ea1Uk+dlbudKr3QrBxc
+CE1J25iIQbl2roJERUdzHKOuIpO2yGbMd8CYu9u3Ij6g12LXxpnHTxaTxm5+llRSy8Nk91pmMfp
njA0KdtInePTaN4vJ0gbiHNYKgu34kg+pDfqxnhJ2gG7utw8qjUw8Tur4bWrxA4ABU0pW9Gdbojw
VSbtJw5XiNVfyaR5ad49RfF0GmL1m7gHYnvKsT6FaiVVrq4183MYGGNKQyqn0UTeA1eMfiaUlwO4
wWqcoP1OyNm51gECO4BKYK/axwK5pbPwkPjdKE3Qr6fzUJIuRWwDOYHEmBrVOeOdJyrXHcsaOl4M
QR6wtoyw2LNkYXhad3/NUUZbI/w06KJRFr0EeulbGm2ZftT1A5DC6DQspewqlMhqMr9WmbXFh6St
Cq2tPb0atR1ewSvOoPjQz9Psm3GxGi0FBiiw/EXlUEb1hw+uSNKnGsCWl8+D7Ci4vzyA89bk0Qpy
4nz6lZekbigVStB+JniWLkVhalQim7EzPTRnKyVn1C1jP639eGLZdwzUTmzy6c0SNPYSagH267d+
7nJGStxfOiNfwyMHeZJ1UHz0dnqe83j+kDI5/EkLmp39qc6lTVyHv1TRxeuQgE2nT/XStRB5DDRF
dlnVAE0j0S170YlKjMvADashdaxef8RR5crdtElNA6Wxum0n7UeN6X2ks+TnenzBQInre8HHEVKQ
2fVyjPrqJqnyNpea68hD7JCZeW3lIXCIw/jpcK3e7yhEEfmBfIiSPXmteMI1V9PbtdJkT5b6S+3g
nGWVD+DlahfD7OW1ejT78UuMNadoXW6HJkX+n2cbsQTXRKuPNYG98kRrah7416Fj6QNp45KQxdcm
l4+4IaaVHEKakAj/vmXBG/q6g+iudn6tjWKDCHsbBEZ4pjFl6CF9zmx9HyE6plkr70s7o9VI9MLH
L0D8X3ZCH3yMg89KfZx7DQyYfoob9XWu/EZ/FbTlaOlNBF1aQ3LCmw9VJ6cSRmIlwZ7U6nbgKrK8
0vPYIVnZKCgeXUz+O7Pk9MsUagGlfhwCifot1t9I2kQamBLwYwAFoUvvWKl1jSvdSTrjHfppx7lt
+1CtY1fpcpPGSr1P9Kc2ND3iUVYdR2xPL6EIYxKSlJ1l0OyJaQC1crIJ4ZdIXPbI1KOLILRtSNUz
o6sVI/Fz3WzdJtB5DgnXzogii0r6Loe8Txm7t1Y6tzSl4StZlfANDp5Zn9bzFDhMvz3NXNiOMPiG
nhxOI4lByo9khj/3p8oYKswg9Vpq5NcuYwMeijs3ht9XzXZj4TUFOTnmDuj51ohA4sDbS4b1YN9S
1s4UyJc+L99TJLvuMAQ+OeBbu2M7HrvH8r5VSE9EZnnlorvI7Z1k6o7DQDimfN+c7XUx/ZqU7L29
kzaDV4OmBGE042x9J1Q4JK6hRs69HB8MGSRrw+x3BJGtotwvej8Vj9H0LfKPzHolbt4Joi+27L3d
DD6YHNdI39r4mY6GnMfrila7TOgDPYVTm2FGaCkZFNDatrQic4iWWtHu8/CnKjlVlPzYBBMASpnk
ZZsoRyzdUa15hY79J9ZdRbaAwhGCICG5NNIVRS4voBbuRPQeCcw6WY4O7SEDNe+mBll7ObIi9Ka1
bjzoxaOlfmS96ogZN0sprnlGQd+gvOkF8UgYKs5tnO4DajYkCKqvGJk3kUBbLHSoa6m/kMf1mWvh
V6lwCk5t9YBNyiPV96IP1m5hx6uLeItHgcFEDsK7kcWtUlD61Ld6OBVMQYLxRVHjVRX+TMwSSNpu
xK0Yz2OnO3b+Us4TLy5pPMaSPyxSL2OGLLbSPUWQUcTUAoibOj9LrR25VgeoFzSEQ29QX2HcbeNq
fMrEe4ZCIBnM69AS2zcXjjGRJxvsQ/1Ni61NUQ0JMxfzuddLZBZ5cdDSeB3XGUL8c2D35ZMSQ+2Q
pE2dgFIpJ6pEm9jlRzzpKC8NxDyAI8W8SvTQv2MvU0Ggn0YgcvFQR4TcSAGH4HXUnu65N4xt86MB
V6Z77wUMkROUFqkH3Np07p1lMsg7ZjxKQz6Iryn7vLqbMghyZzntUmvbkpKA6wOcKMe7n3JRjGG7
vmTLOSMUQZffJY7w5FCVuyk0Nwn3h2h60obkOMY+JBoOkIC1s7Mr1YnxcFt17WUsmXtZqEnlJl6+
AnXybKzfWUme9XSzQBqHAh5b1h7pL5fjve28nBSdEnJUV3IRPiCR9zNFXSfqJtLiU1MfkSy7uFsm
N4HoENNZi+FJMeTe4hU711yWghvbvxOYhY/KVy8QjBwNLp/SpuxoFa3UWHHK6nsqXtT2JggQFJx/
lXmtCXDnHDoSY/SUiGyTDcZKArbtEJ3UKInfxQw6hpxMD0341rKeK3VTjpVrZYjHGiSVrNtwTR7q
m5pc7sgO8BC0VxwtqQ4ko1nolGkPdyobC1lBplhBK/IwXHxCK3u86+KcJn8AOyQYVDD+sCAJ2OZe
godFNEvOCFDLjwPAWSeyzduMX8kHzrNJKb+4PvlpuWyFYsACULxWSZyINzFDRcSak03fguW4mRlo
AIELnAEUFxtez7wm4vDJFKeWrXyrzS3lGXl4Ci3brD+0SwcBSarOXRR8YCZ/VyXK266/6ZpV35Ih
A+0vbC6FhGwdYf68pdPrImNJkNsWX2B8QGbuqn1Kr6d3457QaARC4NZz6ZwStXFvkdvzvEanyHZs
ONV8DnArKfO7nF3jdnY1qfKhw8TPKAQIDdIO8z1EaWrXkyC3DbAe8XZCfkoZRdRLq/t5EvsQcZ28
4jPnj7Hwc/tlVl7q5ETIj8MlHY1j7Zes0pnwsAB7hDo8KO2vUZW2cdlshfVhd/E1oQ8r4odAJj/C
JPx1Qc+l4zLVyLQrt1G2nXtCZV7FuC/0R/rcpyZXuYF3iyt0AfJPpg3V1t0jdGCcfJ2KT3P0MvvN
GqoD0CkPiTUU/yB2zNpiQ8m3SbYc5Vn9KsJPjfax19OptCHvIr8n0RKb6ImOgUo3CoBLqg0Hsmyv
CQRXtxj1DSyK9FwETfpmLIGxSmfxwBMGupVJCYFIa4uehC29UWnzUMEZjNr+LV0KN0qXlZqpl5DA
Ekc24u+ghbuXiaM9hAtcn8IH6rOpW7XBHVNsQkuqPCIGqAkV+tM0RDFom5sBdRCj5ZQZbyN9lpJ9
KhYmuZKsnbLUtvZW3A1Pw6J9IHNG429PV4X+0GQ3P31Xb+cEYOqchh2DL3r+Ng1KF2eOT4bwxbYT
+QO1pbFBsmftjIaicuncWv+YGbU7GLommkU0WcLByLfQVY5tr9a+YiIFKwjaoSsY1Re4wNelp/7o
9ejZFqHq0ous3Cio5HvgUbgh8w4FiULcMdm09wyrqGZtSWjisN582NES00gNZ4rOSTvX7ErEDs7j
BsU6g/QQMtiN0tBmCdnLPlHCbm3dkV553Su6j1I7XZk03z1AZpvKnG7hxLtRj9qEAec2Qp6RIv0D
FNQKEx6jbE28ANWiCBOrNhsdsKJnYyCDWstA0yMka6MtdsNDZ8sn9FuoLCVM5uhed8kCPLO3o8OU
NrKXLZK8tllJD6Yx75UyHAiIKsJwW6R6tpIrc8Z/mmTZTfSVlviCPsm6bTWBilUkZk+hpKJGxPX7
hHamEo7ZwrgEH8jP9RKSEUYj89tKJd5V1Q2fOY667zV+p5a5A13aLg0CN7BinVRHDImtXFx1VRTX
EsW4Y8+Becb8Ua/VIul8gqTEs9lWx3TMVZ9is3QXc2wcpaK6GXAIe3lJswLad/dY03fx6ekrD2Mm
RyGyfKPbqEvGtBphKTw9g0DHSz3UTMk1NKGrSlAdy/j/nFxVHtOg+tVbvZKeigCvrZuFpfo25mb9
M/yRtiKU0a1gzHhZWjc/SyxDsgvBn/EMws4O1P68lI0JKKqhv5InjIMrqT7moVDQMswDhdUi8S2Y
x2iDw4hiwvRJw6Ka8RpHmXhoCKMe4Ps5WhVsEsQbq6gv1DeG7oymS2SMvVgksLYKu0cxKp5cydlK
X2L7NUwjrrpZN75blviOilrrNoUx6oe6HdUPsvXKfYji4Zt77Jg7c83lXlbQnIzSxg7Ai4DHAz+p
G1HP7WMpNqOsFQeDUNmhDDa8Fx1746Tvirr5JoGvOuswMr2agSSnLkF6FQcU3R5pIGyB1LhtJHE7
A7fSn5Rs1l+HwiYATmlb+0eOJwJ0NSJlSKVqVjQ+Rt2Pk3L2ImqadRVJdH7BJLamEzLRohLO5uy7
0cz0se+C6ooIvGWEspRePC7vXVDk6F6X7NtOSuKXW1pFDGOHCmhSHhfJpcWVCMuTCxzpMzZvMlnk
6mCBhyhzQTDaKN6UgoCDWg7EW0dpc6cX5UcxLqC0Gl2cckoI7jkV9yriyjXhqYmiuF1aE9sbjQET
0CyoDZ5rpTwkiU2DcIysdVWD7tOsAo+N3TBSCdIKF458TK1ZYpY4adZXpQ+5z0xbJnATfctZLgv7
M2skZZ0skukPVaMfwavIK5lbwo4eNVcpztNzO0gTzqYJNXsjjIdWmWHWkIVMu7LSjX3TqPbJSlXT
G6oOLYxKYQF4kZ7EVI81RYUxfELM1Zt1LOE0T6A1A04E/bRrWovzE8fylbTz3OGKZpZ+YDPQpQab
vTKWSnpzKXG7gPPaI6IQDdZqSTRtTwvYp9QcHlKDMEwHGidzacUcVzaawKOuMA8GsAr/HC0tOiXR
rUFl4kiRKvlmYUNpVnUeTxstz6z3Ie3IspXTfAERIMfSVaQIf0xT+pJhqtBowPibNxoMlIKxE6Ju
xY+RU5F4PQT2CUqBfmjAiXtdYlq8LbG+VQjUmIIaCgljzNgHxhrS3DAUisXSVG4aqUIPtHhskDcG
sW8ng4RLyUnwtVElVIoLrrn3JQlKJc+sKA90N+iAJ/rgobT1sHFDX54T62JW4bwmVSzZy4if/XJE
NBSahrmxEE1eSZiOLxVVBvH2+SnhOonsYwx+4qohti+oQ+tYlfHDZFfwB9LCVYpGXvWmyig3WOgT
V0JAgK7CV1Jz4YuP+m0si/qsdcX0IHB+sV0L1b97bnit0ZHTRupAiQbK630rXOk2lZSoivl5lAfe
BNbEFe2jvp7hZjnDFLOKtEbeavganozeoO8CSoNbITKamA7FRW5Ef6FXVREX2czx6FjyYBuAvwgk
gnSo6RWh7vlzxCwBapEGoiYf90FKwjcazZonIpS8yVKsby1OmNPoVrcqITiBAeCCV9fUPA5JPfNX
MkbzkZbcZ9kzM2+tam0vA7PkLqUhk01LcTJLmyIqabnkd2mubaMmlTeoQFnCo7qebbQzwFy2pknS
S4vNxS3leldTbV+qQuuPjC21lVJP8xHaPtGNXcYzljSFh7vCuE5BYRwFdsLzPOjEkgKbebHKhJ5T
hU+8R6gw9SeVOQkg9JjAYAyF6QORq/EquvdjOxFdcdGr55n3lhhWXVJ9KRTmJoumlzixsotu2D1B
amZwK6VZpueWvpIkIrs54Q0eWFQo8mW+sgdtXAHgqLyAW+OzrfevGIEtHxoo7dFyzvoXa1TJxCvr
0IDraRAUQGu6qzYNWm9Xn1JxBFLP7D8sZZgfOZOkbGbmgquX2EX2G1NXEGblNIKYJe8nQC+ntjYa
t0mXd3o9tGjKcfoMAlXGhjChvhgxgU5kmvlT1cAy75ilZ/enUfjV3ZJTSzKsiSYvEWYUJokmY1ag
FY86Dg0uIoBmq9WMYwHIO4GiHcJg+i/vIkwVjQ2btEx2nCnwwtJOP3AEFQ6x5B3uZkKjnDS+KzDq
aawQeqE66eo8+C5CxYK1qm5r1DXeokpoeZLMg8lqurI8yjsWaLqxxWh+5qmNOJOx5BkZh8oPasx1
tmAsdkZFSCdZRPzeZboJEObShyHecCuPA2MgAG0U0HMXwBeYqc7jts5QOwXxtUPayBXTGrC0kom+
6bh/OPxY6waQtN3UaOtmx4oH3pbQUszBa1sRGQ6Nweks0r6jcYSO7QQ5VHloQB1uExDISD77HtuH
2Sa3ihoB1VcdC68i2OZnzOuYcIHFcEtjoDudQkOgd2FPO/SvzHQivl/M/XgZlINlVfUDcPHgs51M
XrrS6CmPMqn+mrty+UmzrNzZC2BY3wwlZgXqcJ/BTuE7Ggz9jHF5WOEEyAgtxFyIPEaPLgSOFT54
mG4PGAK3U9Qpm2Ua2rcuXEKPvBNu02pWXe2emCY6WSVpWYJbdDS9ZdQPPImAS+lzIPN46oNp+cnS
JD/aQTBAyiXrxhECe2WL59AF3Bp6S0m26jzTuIBk9N/ZO5PmSpF0Tf+VsrsnjdGBRW/OORzNitAY
kjaYQiExzw4O/Pr7kFl1S0lnVHSya+uuRVpZRgZCjn8+vN87wI7F8GE+tHMDj7VQXvtljPzTMc2K
fc2WdCa80jhfgqsgI43lVdPV5SFJp+nLWEHoaRP3NqRDeRxdK32OvawRcF5nedFrfYVQSwStFs8v
DYkl9ziZQNBKK5qu7igf9Y5JRXKn3gLTSfdCEG0ap+qGDGZAww46gj6114i8rRO5uK6OekiHOslc
/6EVPTFBIlcnQ2E0gVb13Y2lLRvDOOTsQm7BSiqxsNm1XgmBaZ6863lRP1Iz2iXSTvt7GzGYsWUS
dhBFDY32EjDPozm0C6NZ3cxpig5jEPoMxUfgXTy6LBGZkxrfWEy+9/QVz2gM+8gm0zpQaCuOJQrl
q3BKqZEwSqkF5czqVfiTf+NFV3lI8yO+8J2vaLoLrKH87kcz2uxO4WWTzScg2jtXSI4AbTgfXWPZ
zWcNQzTQSnz4aLlgzATvsJU7nZxtWxUXdpmQXNsih+ZGNY8UvWdFLZ0g0AYOKM4bXQn7mZ0jPIGt
iIhIVa7zhm4zfESaHZ8iscKRXNCkH3d5q2sc7FOEPDWihUNOyMJOt5t2b5IsWRjtaZQljzogYL9H
chJ99axzD4kj+ebge62ifVy181mOXFsmEVgMvj/gjvVz70Qk6c6Xodc/ahV/YqGLyU2wfGd6/530
/reEAP8vClEcnGl+Lg7YV2RaVt1nccDyF/4QB9g2IgBUXYsBIKJjulf/kqDY1m84l2GdpQsTHYrp
oR39pzpAM4zf0B6iTFmUiNzg/H/LAzTD/I2sHvZzYDLTwh3H+Tv6AHslVTcsgYBWR8KL9MnBD2sx
4flkE9M2nakTt2ftEI2BUumaM51Kw5tve66ItxBHueaq3jEAVLHD0kuujVwIijuz7ACN0lafz4i3
e2Y6479gkxwTg130ZGLoiwIRQ/MYS8OhqL6GHYlVe5Zj94qEwZCLsCfo9zpd1N/TMAwfc0Ox4QyW
pP/OBnVZcQPpsSXSsLQjwPoQufZ4tbgszsB8IU31TMdAJ3btuz7PbK5c3XLaI9c7IrEG4QzkUD2v
HZrQDRZ5epjCCasUa4ynwm/kE5dv4DTiV7475sq1iAHlto+iByHIEtT4uxXjpwGNUeKhEp1gPDi5
cT9XfXsOoJjjXJwp7wbnKeOHhHUaiNnG0U9JNer7BnDq1jeK7BvmC+pjbvL5dMaNxdhhQiHKnT0n
dy3GjepAF3g4T+PcsU4zNUd/KM3+JDT7R9kXOPOinfpf/7VKtFzeHUtPnBMwXEKatE7+yjFGzJup
dHZWCTefvTM8KU2aCPh6eUGTJvrhU6H8UxL1+eetJFDI51c/cOWMaYU62ch4o+4K4e20VP9S4E1g
dNDbe/tmsrNj64Io2SMKvd6iR1NeAodc57l53oYT6PYQdB6B3Jk6/c8vhpjnk2bmj/fCoMLzqD3X
96xFU/PpI5otR0YmPJ1AZK2c9YrqXMvG8GrDTzFM1xEWw+64K5sIggGAClz6jYnmSDLsYPw0C2z9
n3+KtZLqL4MsFiGzTgbU4razKnGySecEw29BRISnFbB7bW3Y4e4QoRtT4WPcx9y7ErOZvumi1R9b
Z2G69kJPX1trbj5i3aGLwE+w9hYn3Iju6Bwf/KLI3jGg7TCAnuESgEJi6YafRHPQiV4fTnUfR6XQ
uurx7vpq4G2YgrpH9R3NkPKpqWNxPjlFC+cgzIMoMWEZNsQCodM3O5gIpZGfjRgsoiNIx/nMKi0R
/yGd/lu72f+hrK1+JzC8fX+X6Nr+LxCz2f9RzHZ4L6o3VJPJ2z9u3+v+e87/qT7+IeP3f+yrMqo+
b2TLk/7YyCy2JN3B9tQyDbSKbFr/2sjYkAyfKiFHDikbZlP/3sicRcrmI6J02FoMJHL/1lJqhvWb
jToOGwccUgwdBeTf2ccM9JyrmjUF9rT89OV/psMZ7c81O2Bnr2mjH+/w1SXrxo84gONineDC9lHp
HX3CbsKkYldZBdcKvNKN8AAwgP8qwYzZzkDTHHHz9+mjYPKUhYcQj52zQcI53xVQ59tDWMxzcoLQ
z/1qR0nzKvo+uovpbhKvmSUAX4sGH3yASK6EU6ZuEDqIpu6M6AbCaBJP4I2RGjE6F3gxnnWIhEou
7SiVzW7wMfbcQYMxv2l2ydmWLNr8oXOjKgoqcDB7L0Iwq701jLN2nPB4js96NUi0LnFhzvtIzOIt
jsPxmUGX3gUBBpm2I+cp/xHCjJcYoFXxVa+nyLNkJnJ26dltzys4JlwaJwHPufUwCw+IEtOHnWqb
8CGxkvKNDYM23OB4CXKMpPINoFGZLxdsehuanfTeXnVa+UJAzSQOI0Eg8IQWSGec6vLYkvhB9IUj
1R3rJ6xW5HLkH5WuooVt+W2NojhtIPV0uBjuDIiE8BIX50LgTQdspUKQAv9SjnVPX8FXT6pcbMLs
LB2HnTcn+YtnV4VxGMyWn+OSpfKBV9L8pcCcAUJdZke3hNTP9imGVPWHq3mavisyzuNnTT1r5akW
6slM07+Jyv2s93Df0OvSpSZKzjGPSaehlCzNtL/TxxIwUheafl+nmfOSuAvTIAVLeXSGuAMQrlLr
sQppDWYY3nKHcEf9Ym7z9N3Ch/hxsAitYGaE9A89Q5g3GI3bP9weO3PIixH9B6yxYei1zoBxfV8D
ygXzUNFJM/veEztjMAxxE8uwQXplcygKz7hKYiu6zxKVSER12M7s7CJyfVoK9DuDIfT0Iyz02uIO
52gv5MtM13qK8WN4YtQlQdGiBfSDUSPT89aK2B+SQZ90eeVFWoIJeb8ovOwcS27y2CKcagYs1Ghj
YdOF5jLs3AZE086A+i6hnsky248EcIbXAKpNCKHH5p+e30zJY9n6rXXMCTFUZzQx4JcQbOlPzstk
2vyevt0CbVYZk/GCyBUfKgJ01vksbKGx0+WAKcEbNz0m61yacNdtMhP3AzxZoQUPwoItkGludxAh
R8IrrZwc88nCVim6I/QHjkcoetvZd7Qr1KEP41x/GHKYz5CAzTh8yU0/KR77RpjqWo8nNH19ht39
U0mYX36BcUQ2mzSfmhr1Iv4A6W2OEjCmx8cKdKsXS4JojM9vA01qVOq6rokouaiz0mwOI3ElqGhC
IGxWApRbVqC6Sel3dkOM294k4mfelWnYfkn5iPwYg7S9BCmV5TznGse7oC8aozuUXSLgiRQ1HSwY
/eI5ypPY3KWpyh+xIRI4wxP3kNDDcFri5YoJbEl08DFc6QDOqdyQZ0bZyXd7IIHvClcQMMiIuA97
n5G0pH3xNd3jXs4yI49tGFv96xTb812YJq7cs+6myWHM/Tq5MprCJud5aIruVi8FjQVyjewbV1Ue
/R4/HG7AMs2c7x6zKDmmpVJ+HQeNBKio+ojMWR45tVHNiHhgxyYWn3TnS0UnP3Q08479KS3unDRJ
bhOSmWgIl3N0qiZiGIG5hmiA/iKdOTzixePcZPDH3rDm6J/sLK7fEjKwCGR0RvU9i/CxBrJRbVHv
ZJoA5TQ4fUkExF2RnlpkFXQHEstbxUkn4U0imaMLblWSdzd+mQCl9eWYkQeGeQE+9FPCYMGgUc0x
CiGDUYPN9IU5AC0GiQe3Hroq5GeZEIhIeolnEHKgU4BZQru/4FvjZxl3rMafPsw6LrKTtAcLWUzv
RnjdXl7kx65KAIyHQc/Pibps0PdgmBteZ6XMHgQB6m0Agsmi65PI8DXPhFvtiLSyIJ778AKRWCTJ
k0QC+Zy7k8mfwdt/tkUKm1RNJfwi4BxuGY0e15cQeWVOV6kQRKZUJoKZeZpjImEo50ej8TGWNoa4
1Xa9majnMkrdO02KtjvEdJCmK9hKyGzqIvzATsRxd6UXzXjgyE6dcNXq1KmwBiRnoReD7Tn4qJL8
4ZY9gSP9SIAge46/w7qH3htoXa0I7hqqE2SdhGdCrOZVs7wDTYGDSz6222uOQjtRu/HOgcG+YDF1
PgQZaYR5MBTedGO0jv4MI4MARE7bsAicYQr3SR0Ob4mt6dE5gDls8HZEIruPrNHpwPZ692FEA0vO
77QofCzNkjDTRsTaUPvxDwfOlgC52E8WQZzCDA1irdIvi1qXxK+lPmaBpZl0Yi/NuRXcxkZYxUmt
DyUcN6WRbDrQkjmMLVz+kagml65O7d2bVcY37NXk35JxgRVnnibp95zdudyrOWVJK8K5+tqZ3JH3
U2pYD/hC0OLlyth9YV7oaJecrjt4dTLBWWdEvnOqcbSjciVwZamK7wb5zvQmOhNNwWSht2UqW9p9
3Nnx05w1/o/czBQKZ44IYo9gn5dwMO6We9cvuIGZsXeWipb3yXK7ceCFcaPe9UaP6hAwg5QK3yMr
1tfHAtc4CEwQURJDc+486kahrjViBHNR3caHDnVccenSnC/2uDxr7wTEi+pYS0UbI5JafYYTvzJ3
FTkVAhmX4T8NNEO/EMfpQPLM0L7sU79qv5h4pXl7motlEpjo8L+GbtjIk7G2qmQ/Sg5Y9LzwDqTZ
nxc6XS/Wp1ZWYRNYMQo3eLgo1w79UCIeAEzlPycm0hvQhJFSvUuamrNKNo5xeKQZnWNhDgp92mU9
hzSFefR8MkdzWF6Tqzg9I9AohhNnGOYPq3WRWOJP4I2BQ9OkuOxGD6q/D1J9KdC7/HBwp/yW0Q64
jyZwTtgDyv9eE6pkAxrn0zvsJeKE565unsMRxvVRzZp12YY9CSxyslt4tX6REKjSza9W28OaMnPN
lvs2tDTmqKenoNMoRB77Ja+BVMXOvc6HHhAxGVlQ9irHtnoXt216YZH+ayJ0acJz3RkaNC/tIG9K
jrQ/VFSANcxJV9x1bd68+MOY/ojkSI6KPrjFsBsHK3lpVKSgHyVt+dBj8/mOl039NVVJCJFo1v37
1vUzelWqf+UIu2ROGqp9Y2cmKQsZIx5RFb0EzkB1+pg4ifFhttN851fNfKo09FL7pNHMl0HXilv8
HwkNMZAMT7sJqvGb3cmKs1kX+d8b0jq+TQiHX90+8vn6fVd+r+e2zfd9NvmX0hKcscI4xOuJE6b3
XDBTrka3N2xykNFu70hjIVmvlPmMRbBuwm/zYetfKnfCcGCKUlR7foVYa68Xbv1dNI1q9wQmIpUg
xqK+j0hfOC1iQgB3ZTR6X1vbNvsdbgxwjO159u8mmrvJ3gUUPzNY9rkwe5n6xrqmE6g05u3E2uxi
EUZGosuhySKYNkjt3GlpYzBbUPdC0G9EktPiQMRIZ8FrEei1Uy3fa7NrX2wtJV5AKISIAYQelLm2
KbVv4VioN0EO2H3KikH/Atskguk56D9MaQau3c1pXx2Rg4AuzaHFgSHnPs+tvtNgtMhRTIHjyMHd
ZTWhmAizoYSe1s5s+ztTkeOxT4w2g++skbBzKkHgOTTTPViad5yp98SJCtb7yka2E062B8Mlr7X7
sAul2hsaRhH8lfCxQd+HfwdnLe3gleVEnnHmRRaszmayr0Yk+sVp689iocjmiiOmGMQ3YdhLJBoI
PaYhZBJh2CULuDuZV7LBD0WKRc44wNYOFWfeg+nBuqDB57O7aKQcvUpmSbHDT4ANCPd6/YXGIbfA
Ia47wepQLLqV0JXevtb5oXTlR+uJ71zjOABTHF9VfE36vlVIhfwcjbXZwxuafTho0vbix5jIX29h
yMTzBffLqjhwCyMBlAxd9T7raWjzSoae0vFpJJkB3DVOw8rHgjMEg5l2c+nURIxEC4sMxVpdHbyR
SAiOyc6EF1BueFDfm1zER3tUxXQg5pzLZWdC8YKCR0Qkur6ijfeVI2G8iqx0tR09dOUfOydPaRQk
0ciniUm+PuSOgX6vm0aUZIYhvSO91gkgFjSWmweqbCQKpODQRDLnHimoI2mB535XXLljOphHwuKM
at+MxNjsCoel7CDJQaXnMIxGgicQuX97dzDyDvZTCO2zzkUi7nIrzSGgaBHXUpf42ei0siq2qZEe
MUps+oLpSTFn0AbHCjo0LGSAzzOJ/q7cR4TZgR4Nk6V2+uxgoQHNE5qEw86CDMsa4Z9yoOnuNYH+
7zwUqHN3NPQylozMqAVxSzWrLJId59qf8TFbuOPa7VhwvD3pSKwhEFKQEX7VE+BALzBC7c6G6/s/
0larBzLXlzsxXd86xAptEPkemT+hHhAUmoQIbDng5wLvAmp67Q+7yu9MFLux7kcPut9IpKFJphpU
s7RX923spC3OBjSgDtRLvOj+Jq9BFdgi5vKJSGNXbRIfq3uU8vGxpX+kMbheytHTypm/thXHsGBz
Azd/roVNeBgcTHL3bT8syelx3ns0lDpsRWMLV9d9V+RZfZo3Lvpk043hNkdszNV1qPI2PYX8VEMa
Ih0rOWX/TyLqmzj2gN7EJM8gaVUlQuDJFfQ/lz+VI4GMRw9yig4hVOvkV47aNLdNgVIKBrRb18da
6GVxHUVkau51DUz5eowtdkojx5bnJHUImz6tBxEbAS+YVcesjVormB00fHvZO7INsq4La1qzk/OR
6mo2Ttxlez+QIOlb5zGvNu/kTDDmF5h5FSaEbiJnlCFNjUoRjn9y5juT3R+iZoLMpM2TmRxtNZQI
XU1m/0030PU4ZHkWOsfaS10DtRMuNyc2HG8Ygn7JYXCBRMnBG6y+wxFkrFz1hcgefbjOoQ8QV8wa
QdhEVbcE2yFnR1WUkLf2PDgR85EYRdI4boeZC+elb+WOTeZo1hFhMrHET/XQkkPNrM4RH9eOc7T8
JAzveyzXDayPiJBkOyblbTo2XHNbruqgJwETCtXsCIEXi4MJCvRlJhtikJHxQKnNRzvy9tzj6xSK
o5DxqYmQ2AjMXKI4I1Q+bg5dnBhdINDspt9JU9CePLcomvO66mbvAO5XjYeJIS6ILiwlkLTVTZId
NYF9ITHbnoLFfqc+EVbBTdOz5xREqh5KvLhhqEW7JlUlnaLU8KaDOZtpHHSyq8kdb0ZRnyVZ0Xdn
bPBY48CFbcVtg6Y8ve3d0mhY2+e6OMGUvzGOjkr6cT8YSWniWj5E7NwWQ3li+aN1qXkjGY+41IkK
xjmUit1gWu1tip81pOjI0XZ1V+f9fupbjr5tN4N546aICB6GVHftidIl5gLOORZ/ef/ikVl1MmOQ
752YVJQIRmTQ1YFwvLoKqtLhSBhXzHVV2tNdYmCWgjZ2EedNZt7wZWavvid60x+BAYyFGjH65RSk
gIJJ0GYuBhJJZeCjYmMZ9BWIAPMSJ4ekAfxWqf1UpWTnTV1KJjX8mZCLji+v8XIopqPGZfcpgX77
6A/lBDddMGv3YV+5L0ZiZ98nY5o1xhyKFoTliaSVnFbzuUE0PAwok3FmtQRHZDsvuM+OMVFSiFLy
qT6Yhe+/5JqERjnjU4a+icMWW0kqYEm3btX9oPg1UkzdtpnOBxIvpm8wEfzibPKj8bHvi4GQc9G2
3Bwjb+QoioCor0DEoqxPryimEkHrNIxSXWNBk/T5CQz0joNUpXN7tvDrjCEyC61IckT1tQBkQ1Nn
jAS/MEvUNQhXGt2T9c3R4mtr4KZ93WmGP6A17XFhqfF0KWqJiLV3wGs1Bw3nnU60ao4q17SR64Zp
puDDzqYhYUP0rfWuabYdYuTSlNpFTDeeM3yYNAAUZT/q5b1RFU4DZ2wUMIRFZmPC4gEf1cdqwjIc
Z0e7Ry6MV4tZ29rRFiHIZzyQZoQAJNEQM4V+Lk5xfQ5xeGkqUZ9zLRzI6cm4y8U0tADJTwgsdTwc
hKQ7G68oTQmDyCO98E4JUXVsvruI3Nsy06fxvYM4xmG1zXsumBcqcZ3qBJyAPhgmI5HDJsR9OWbl
yGrl9W+xHw/qSq9bLnmt5eqDgfUBGQV0VF1IvJAllGmigu6bYmq+Iz2bwhdpiqy/zzCWBsuEEMaF
AcsrAU62K6tOphPqZRquT5yt4+6evEa8iWYTvsIPM9FI4cJvJR7FXQUc1JNY5duoYW3pJ3STEnQz
XyJmSXXL3hQ6zY4o8hpGmNFgLzfnzXlqRdNDi/VUejJ4FnnsCCPda71d8N7UxYoKl6P5FCSgEYfG
1HosOqIWw6xqJpAJ8otEbRGPUJfVGOfv+hQ273AQjUdppAA/iWp0XH4am5Ni0ixSZ8W9sT6JZEaU
o2+Us3YGbQ81fqtJ99KtZWug2PRR1qnaC2nMGkgE4VCV3njioamxYbHUHJkNruQsaOR53XWalxQ7
1TUKrtfcE6PsLa2vndFkqP2ZZ0ZxoI2f4fg1GbjR1z7gEmiR3jz5Rh3/0HAlweVlyshtjiu/ojdQ
F2YwAThh7JZR40R0VvHXweRJ+xBHritQI1TRuAVo/LOS6JcSZ3S+lmaFMoNuAETmFgblCJtd5T8I
rBpxBPYVqT+5V2O3QZpTzxLTQZts3TD5MABF+RXcGEkbsZJEqQNoduaBZkaEmR5hIW+NJfHVADzD
3c4LJZTVdFLtU1Va6Fs9ordvUyVxczPkZCCLsaNj4ubZbVaOsdorL9bQ1IjmAR5iSq717EAnk5Ie
H7j60moxBpV6kMFJ0lIdOR47ZjMXc1zX8B2b69l9qUZFD9iNzPZ9cHshDw3cuJvJxUkfnZLLNBv0
uT7NmP+3Yel6HREh0XBrc1epDtz34nfJafEWZITRGWSr7qQ/9WCDWovD4KDBsNWSqEZ8DTmOBTil
kvccJNKFd+P1i3FOspC4tEp9w4ZecN2o7fnKd5OmAFPC+JsFjJj23TykXCCRJ6MvLGwI9kGCQzQZ
7mnrvWqJr0ZWv7r4qKJc4qoTkR0NXnSY8DIXl1rosJMnbQHzMgaXZldLFokV0qjs2eZgPB2aKgL8
hwml7kM6MfGZn8NApyuVjB6KfzZfNEWuuhp9DTs4mdrpO1eqxGF0K+8Sn0OlBSUapEM6eMLE35CY
8DMTtV2zz/08+XDIModVLUu6N07tALXYVsqROVUG7lQpaQysKVAt0kNii8ZeZCyc4FpWvxhPw6ji
tCzBkqqM7Gs0sBleIg1ro76Dnm/cR1GOeruCRCCPpMV1IfID+C2IXiMO/bTGCAIGrKE7JLyW2yeC
GzAQ7r/iLlSW/ujJ0J+P6CDiG6vVG2ZRCodsh4NO8iNjnQcZUVgBAOkM3MxBNGw4tXXdvPljMz4Y
VBJ2KaGB30JfoBJ0RaXd5MRrJMDkFYqbqJM0wfocI7eWQMse/NYypr3VatzrGzIFk2tOh95NTS4G
QmLgxgWp72DNR8DA7ulMKrt+6PMmfvKbEcto4qYELA5b1UfPAyje62bTgOqIqchQoKd9ccY10Lzj
EueS6sVpOejs1BkPOAMVLjOLNt3OJMlixvYJC4+91Vht+tzNlfwgmq7IdnqR4/hhz0V2KyTkv4OJ
jzGYTwJNfO95VX8r69nXLoRbYoEAzZHob1umT4KMghtyjzJ5Ytd2m1x2vN9l4y1x9wrG9qNNF6re
s9VhnjIOZf1h14jx9thJceDooP1jFIFJ2u2Aad+rsJwmO0yYZT8iqsCtS6/z6u13DsP/79X/F06a
n+gci4nyn0yOv75mGOy9/tkXefkrf3TlXfc3z3IJoIBernukKdF7/8N8Vui/wV6BVk3Lnva8afzb
fNZyf4OPtmTB6sJfrI/plHd/OByb1m+ubnFV8x3PXhxr7b/TlF867v92ntV+j/mCF/I76+cTe4YA
ljgT9KmCSjc91paYwKk5P34ah7/gDv3s4SvKkBA56DBE98DQikeCzx5Mu/1FvsTPHg3r7jPrR1a4
mKV+4QS2gyRlXNR7eDX9yur9Z09f/v2nUQEsSGhzVSIAIf5S2/6FlXT5H5yWnxK4fvbsFV9pwsjc
izG1CAjdeCHbG+keRIhtA77wLj69NyKJjqAsjbgq077Lx+wVadTGb8ns/fzoCJjJnsdCIEJNQO0V
IYPKyYuNL77mPQ2dpmyTmRLWdLsiF3fISReHTaOyzmO0ased0Jc5gdsW0R6G5AfUrfoX1K2ffE59
IW1+GnLfB0TPcoY86mxMLgptRP6jbRt0fcU6cxegms3UDpDnazeD1L0zu+jltG3U9VV9dlEsBm7o
TuAU/TOACNIu62HbmK/qs1Jz2xU1j3aLKcWkpbkkeuZs27NX1Zm3BKNBPSMTqY64amMJSAy8fN/2
8FV5hmk/El5R8T2N8keaN5dJ0Xzd9uhVdTJLfMtY1qxoagLyLA+qCy/+86OXYf2LZVxfVeds1wJy
MDZpqSW1nbTi+UsE9Ry9zd8jQv7PRqGvKjS2YjLXOaEGpqGfubp2Eakf//nd/7qC2M/+XEGzTQdB
6bETGEqcQ6rBOkxu2iXEOmBvGGIyU/IIk6ZCV2eFF2YXvWH+IvTiZ++9Kk5B6DCqxnAMBsu+xLbj
tOC+vG1IVoU5K+Xo1VL3sECCGIQ60/8ebfZf31H4q8LktJzopuY5QaMJ7zxyte6DeNL0YduLr0oT
74tBx6KFWQLn16YlAal445isCtMURT/RTEJJp5s/ZgWE6WjG87bXXlVmDMnGGemnBApL0SOdK87n
lt1sWmZ/J11+3iJKrxZNNHRjkONEE/rOyZw099tefFWVGve/xppGO0hq80E59o8k9NLDpmev44og
mFgRcOAYJI1zQc/zesiGX6TD/6R0Fq7p5xEpZtFjW6qmoE9yi6tZep0r/8e2116V5YSUb6h0ZYO3
QPXxBrBDSFLbnr2qSxMjPpq948h6YmN77/ofWjFvHJNVYXbohupKDlPQ6uodvvljZL1se+vlK3w6
ohT2aMx+ymi3RnHdV/21HpE2ue3Zq6o0Usuu/awdgyaTxUWZiP6+N6to2/rtrepSYLNuZnU9Bsry
3mjM3MH5/cWO+bMpuNox2woeTaZgT5liWqzkMUIMY2/ToRBL3D+P+DAbOPQM1RiEvToBT7ztyvGw
acDd1W6ZQULTCAKYAkszbyzYByKMt81ud1WVeejMDVJANjQXKA3exyV6g2jje6/KMo3aUOAfPC0N
1qdS5BdGkWzbGdxVVUaeHwGZMkuyUssP/sBF1iudX8W3/WSioOH6U/WE5Kl3i2NvQAAKLtsxhk6I
sbeVprv80E+laZUmmGHDRBl6jH9K6wmG+cZRWVVmpGWDTXz8FMDhRZUNxru38mzTUVa4q8KEVk0m
oiXZ0mr5pFcQQHpd/1ViI7/7/36WBZP485jkzRzDCGFJqVpkYKVrHeaE5JBt5bOqzKbCj6Sp2dTE
VN/KKH7qM7FtwNdJ3qmBXXHMOAcWh9lbrUuGb2nebluulqSrzxOlQRlke7KYsHsq7wH/b+c437ZY
iVVljoh0ES8Uyz6PCmMasE74ZfjmX39KsapMm86s7Lp8RKVvnRe+DavAut/0IdexrjE2zSCyGVY/
DiK4sS7usZHa+OxVVUaZU5NqzIhUXjIHuTQIXccsYduLr+qSk6C9UIw5+7TuB/ZYBnY6Q7nx4au6
VDDCsshKmIOEsmBiUL5CTLjZ9uKruozNJqZTx4jHhryyMiNwumTb+VusqtLvdaLEvZQpOGvvo/Lf
bH3eVjhLeNznwoEPQMCgjQFH6g76IXRprzZYMm8aEmdVlYMBzw/XAPaGcrrNfBAUN8uutz17VZZt
XpA2gA1jAGexOY44651hUPorDewylf9ikXVWlUlHrk09jG4CCfcpiFSPcSmM3W3bg7PaM90s1TAE
b+ZAzXj1omnwX8NQqbNtI7MqTyJzDJpSzhjAKnrQRXrrym3l46xqU1pGj/TYAVXW5BGdB9oui6TI
ba+9qs2FravjLDHj1WrflGgPirb8xd1h+Wp/9TVXpamZMN0SncAevU+CetADXarvqigOBgE1295+
VaIE/qLg6Ks5GJv4aODKjgxl2wZkr0pUOBAEI423jzAOokHbPygQlU2v/bum/tMBKxrNyK1nxHJu
X2NplmHvOjja+7aHr0o001HjkbkxI/uTj2mrXpr6ZNuTV+UZunlsQpViHYcbkEv3nbvsP7Mi/2YD
Qtir4ox1z2kR6o6BXlTPlRl+1ePv2956VZgTXCvdn0O2tlR+7dLyW/xL2ftP1it7VZm53iYNfo5s
91EH5cAnjmlqN2Ji9qoyrdnKpxRf7WBOpruohJ4EWXjbkKwq040bb3BrDWliXZzapbjr7HrbYmWv
K7KohceKgk5AapywUG0F5tb3tlY1OUgNlsNATTZLbG6o3/vTxiO4tdo045lAJ1RAENjn4RuH5nMh
7W0rye/y+k/VXuU6npd6zYcs3Ls0Eq8zzmsbn70qSZGAs7mJwEtRg5iDfr/dJbH9sGmaWKuajObU
zjIdB3GnHi9GT78h6upvORj8D+BrrYsSfVyi28zAwqrvtaYjGKgfnI2DsirLtIoaux7NKZiq5ApH
lVMtkrfbhmRVlEJ6SYVmE3lbaT4l9njn2YW+2/bsVVUmsW/jSUfpjGZS7AX4o+v137Y9e1WWg95Z
wp5w4qiS6S0nKJgA62bbJmyuqpLg2qQbM3Bqf8q+EI6FioiLz6b3NldliSbZLs1wyf7s82MZDqeY
W/5ipVr2w784nqx9VoSHMrQWi2NmmlvfkyHcE41zimB+51L6WK5sLCNzVaOolHINuTu7vZU/K7PH
KjD8sW14VhWKjAQPm5npqHPxFqP9MAvvadujVxXq6t2I5SfDQ9j4bTaWe63yNz56VZ+R6AfP90AL
ka1/iQgEyMtm46NX9ZnaydRh074AejWmpQ4O01a1DRYzV/XZSrdDbJDOOLbWI8TAaTwrsTH8xWl5
Gde/mo6rCs27CBWv27IiapN8Tse2u0JS0f1isv/k6QuZ5/OFE+8AHJwiLpyoet8iiaW9PYjXTTPF
WNWoXTiqlstJuS6KG5yG8Wtq/W3r1poJNNq+OwqfdiY4Z7zDeXjY6fDUt734qjA7iWFQxYIYuIN7
ZaLTiSxr2/5mrArTggUoMCKmd5eH+DTC+Wy77H7ba68qU2E9oPCy5kCb35Ve81pI/3nbk1eFyX7f
ha4VzYFUJRKgvkwvFgfOX4zJ8rv/xQxfnMw+z0HTVqVuoTrGfy7GaiuK8/FL7szytoN7Hh+2/ArO
um+fIsLsUNDMgeM1FzUpKUbtbbr+OOu+fVxbLQt5zOhMxqvWatfpZG6DVYzV0oLDTIl2kGYssjyC
efTqrZ+SbUuisVpYpA5bE4b5GJi6PEFZczStXwF7P/miaw5TGeOiM1fs/F6XVrjUIKrEO9AVWrht
Ufxvzs6tx07ba+OfCAljG+xb2HvPeSaTw6TpDWrSBowBm4M5ffr32X+9F43bNJJVqZWilGGMl728
/Kzn5+uYnBnTVu0NCsxGf6iT6BN8Iv8MmSiw3PlxNmYZIIgMXchn2jt+x+iC7hU0OQbNFegkf3y6
i0tWWbi4ndH48JdUaHYCcSnw6j72FhegY9FvK3G8ghUDnHiP/lMVN78I0usi8i9BGnuLy9QIugNg
hpmoJJDXI6BrsEMOG3JveYHdeW/2FIsi/Ey6nNTpN/TaqiLs4f7qAiRJJjhevKv3Ghzw5tIBJBT4
5l58zg4g92pH2b1sKLzdIQWCLwELfLgXoHUkgW7TmCv9vC5otoQh/UKjoInIpTfNp4kAYYzO3PMa
77dV3527cXkXMuJQA/84x9e4GXbgAXBZHVt4iLj7RTdvYY/2Zjgs3ROlFqRaB+BcIC3Q5nQkdVDx
/X/q5b/vQ7OmaM7GlfUZ7Rsv2Tw9jzxsveLSm+FVW/O27zHaQ9p8JUhUSMxfw4bEm99Q0gkl4dJ7
tnV5s+FjtiK6C3u0N7uJRg89ulO3M9mhht7dFSQftIDDru3HOZKmywZHFoK5zWCNPuln18hL0Fv7
SiBYZSkn9v44ZxEFVkrRhyVrw17blwJFo4EoUvEddWWgOLfyw1SbD2Gv7QVk2U0EDAtkESWEs7dZ
edR3wq1BiyC89H4cbrNH2Wwl0Bow7Lqxu7wdouoc9t5eSA6g7MqxxhK4ss0+L6tK7tphC1tKhLfr
1AdsgUCO3UCfjGCzh97kvO9NWLwLLyhxgIiAAhNI8wfyFI/9Q2nGwEHxgnID9wU93mhrRtvnnEM/
/z1D63bYgHtRKRqawtgPc9Cu/HlW0wNcEn/x6OQafv/c5bkvBQKktYZrAsqGPNXVAeYpWtJz8CHk
fczY9GFhbfyUHZt4jdDBBNuB9YkIgG9rBqjT4Cr0+PI2TZPLslHmbq4dPk9rsk4vFAZ3OOrMcXmH
4nj9Cq+yyAQpW/9hdmrmedoIuY51Rj+zpHzgtr8NGmpfqwNDMXQir2Y5N6R9S8b5rtRzWGcF95U6
e21728Lw53zAt2dIX+cj7BzIfZnOCk8P9FgbC9oOMCD7CoeQJnBAvJCBSQT6BwgcA7JeP1pY/XCb
hm3tvkgnWlSfwqkIJ+Mo7U7JgC44na1hi6uv0qmzGfNtOuy5zKahYCVaK9E0E9aAAzf+H1dXVa/o
/oWV5HmIu+5ylOBnCp38IlG7LtH/EpK+UCdpYfcJm2B73qDgfi/N8hkgLeAMswucQ2XQxSP3BTsT
TK8MpIv2fKyzimE3OstnFBBHHrYe+jpAma3aHjXuY9O1fGz5cl9J8otHX/eZfxkfXwcIlYeFEwqW
QxFNzdsYIWWBzYkADSrpMWpBC4GvOip3qfopGSyaOGaY5KxdCu/RPUxtyH3hkZHNxDSHZ+lUAvjS
wjsGTaAfw978Omx/u2Taj50DZ483j2Ejo+Pk0jfD72GP9jbnY1mJgg8bJg28KAFyuI8GG1T3QB7/
41t3UaXQ7C6x8LbwGcqzUcJvYIOsNuzNve25HHlk8OIMQsOMnVZUskGaSWhYApp6G/SgqnTuUmi6
6b5+TpoNLmkAS4a9ubfUHMCQtRMqq+cjHh9JPQoA4lnY9/TFR7CR46IXGp1KsNoAhQseee3GAx/u
F4NjPezAw/AzHI5UPqvjaeQm7JzCvdT56t+/ZAKDso7Ht2np7zIlwjYOX3k0MDpoNIGjCyqKwKNb
YX66TntYIyH/h/Koo+2oJjxdJfoc7c29ousvto1rEP7Lssi94DTwuc1ALedoChWf6zR9FFtYoyz3
dUcE1vIbK9FvWks35XUlgfpDphE0wbkXmjAyhqnNiPeOXXWXzdnTQgPjkntxOaJHX1ONtk06JhGo
A11RZ504hb23F5isHWZ419j0PB2HuAVW6cPK9jZsUHzNEYyCN8gyGjzcwpBxIZ+PfgnL6HzJ0TIk
jV1hFIWdX30cUsDZZNhdB2deWCqVLjFVmCdp36nTvrAL421YcYwz70TLjiyFvwF6t9BDDFrupD8l
Jh3DPqYvOuJHpasUnMEzGFLPoo8vAIMGfkovLldsDpwPB9ygUMa6m8eZQZlaJ2GrrC88wseMF1bh
xbdyeUON/LMd009BE9yXHdUL/I94muDRK8w2M0BQ1JiF7cfMi0whWrvtrE3PytiHeB8e4CkXON5e
XIISDx5Us6KBPSPVeRn1K1wNSdhu7OuOYKnXOuDZ+VkD+ATn9im3QC4Hjfc/hEcxhxTd4cVjccAt
FbVrGKiF9YGDr/BjfpUpuJgcauPnfXMFXDyeOUA6Ye/tBebseNpVauHnaDWPJcisOgsTMHNfdwQv
oTI9oGE+A+9X3lwXlIrsYdo37iuP5qptp5phSPg6vpUuvknG7jVsSLxsNrVu3xkF0hXtObBHjopt
gSln2LO9/TJzMTyXF4yJ2CHU7Zr4bak7+1vYw724LNdJ1G2GbzlucFPjuo3z0c6BE9yLTEGiHoY6
aLqPBvHU7fLjGuhEwH3lUYwGPNN1SwqsublpGvVOCRGW3PvCo0hlcQSV9dUqwGY9TMhTiXZTU98H
jbgvPqqq2sHNG59zh2M+3+IWoEwS1qDIfcHRFpFsMjvenUVvydzDbztyYXd43Cc8EQjo1dyiYLCX
7I9No7y8dDJMQ88Tb9MEFjVe5XWqOMALPirFgd2KKxu22yd+eCYYZ/iNoqWfbM+UtU+wcAv7ml5w
kg16DARReo5Gd38Afw70Vlje5ouOpiE2E21cemZAzy9JdYYuLXA8vMCMccumxLX2k7HU3AJuoC7j
NoSdS3zBkdkSeLSBMnpuk+qhdM1HvbdhQ+LrjbqqVySbFfJ7Hr1QrXdgVKqpCPqUvuCIXBsfyx4p
SqauqJ6putvHMQsbceLtmYvJtigB2xoqrK0tOrOpr3BzlWHZla85quGPKWoG0xdr66zgdOre4e6t
DPygXmxaQ7a6ijHqpNmB9EO58sVpw7+GDbsXm6Vb2OqgCIBlAE2KSWhA2/YpLDx94VG5b8DFOjxc
m/LblhGXd+sROF+8rdMmuKdSFY5sCYjB+RrD3jxb+a9ObfzfT/e+dmeDHR+uUbAgdvBsfjpUU6HZ
t6MUhvrpYsMyOV/FM1g24HdAx6ku6+d6AJ80nsKu3nz9TgpGLTaL6yowcgJAMuDma7ofYTm/L+FJ
EoPatcWUBB8XWMZygP3edrCwDMCX8NgeD5/hbXvWI7+HWfDHrc++BM12X8CjQVnaR45hAb+WPddp
Z9+AdKw/hD3di9QGbVYSgGE8XfAvS3/c2H4Kq9fGXpjCdx9JSw+bMIAMAJRVCbJFC3xA2It722i2
2azCPIf5LoxPwBPQoCKkR+CYe4EKG+Nl3tATfnal4yebbJDAiqMOWx19I6JoBFYMEEaUPRv+iDzm
NuVhiizmKxrbFVa5tMWL82tVhdR6ws0+CbvxYL6ocd2qcZIWNdU0ZbliB6hQW1UGfVBodX88fgLY
Xeq+QiIqK1adyoT80Zqwe0R4Df747Aa0yAO0HRy29uWBwJut3H/VuHgNlH/WVJnvRlRH3P3/VIGR
Ocgl3+NleR8yxdnVOfHv1zTtBh/QEiDdK9qgu2S1+taLJg0cbi86hwpW6rylmCnzcSeBrMoJM9//
+8X/fSdi0otNHu0gq6Y1PJS2un6zR18+YndSF7MsYf4k7IqB/PvYbAmO+6LH2EwMzfOJzuZ7Oc5j
UNbIfCWSkBswXX2MkXdgYsH2bUtFUH7BfCVSDZwcjQ48WsQZ+t7E16ZbguSYzBcikQwyOJVhTPgU
PwEc8Tm7WrP+9yf9yTQXXnTGDJA5l+FWIpp2fb/CiPjCNUx7w57uxWcNJ44aBqH83EbibetRCJFx
FmbwA2uCH6cKTPo7jtYdXKi0e3tnEqhIcZaZwqaKr0aSoK3AxRqDLhX9o9LriBbGZAh8uBekK6uF
UTMeXov5pGb6IPSvpGU/iVHfmMgqV1WwZmXnSl9hGT1Lpm9bHwnQkOeZBC7qV+z438N038qhTCb8
lLVqmsexj5aCbW2YQQzzlUnGNOPQJJiUG933wi3peqoS/otM9ycD5MsTDETfoNxggVyjpX+/19+y
BmyXKWW/eP5PIsrXKLQZ6G2svL585T6kdriLSVhrBvNRzyAPRF21XGuLNhlzMyR3jZBT2Mbh65/G
ipT7TCp+nm3/JM1xW1PxGrQM+PInyKU7u6V4b9U3AA4NQNWiDhhUWmS+AmowkDruPWq5JQRr566P
7/voCBOFscwL1AagAWAl8TGdMU8z6V/SVoa1ejJfBBUnbIlA0YYdnFTPKatuszCjOeYroI52OuIZ
jKNzJNh7x7sn0YN3G/YtvYJRAq7RxBjKxFttAcdyw+ft6oMf9HBf/7RFI2huDYZkWfcP9QxzepBx
Ap8tflyyOIvssEd48Wk78nLsPkRGh81vXzFECJgVfMVqmPXJVRt7XCLYCIbt0L5giDLgr5YsZWeg
PqsijaOzs9MROCjeHkrqYRNlj5kCYOvr0rkXW5NPYd/Sy3JxcmaGj4hLiBHe73E8nRs025z+++E/
WcR9zZDWHeQIEKygSJx8LsEIQC/cTTceYftzmvw4V6DOrpdxhEFoWs87PBf6+b2lqw5LFX3N0AwD
f1vO+KIzaEsAikkItuqkCyq3MN+xKAI1S8fXoen08J5Tegc8WNCFBRjgPw5L1E/roEuEkNa2zJua
v6sWKcKmou9YBGZZQtWK0/MytPdN374BNRV0U858zVC0QbOswaA5u06CUXOsttiyJSz4fdVQz5Z2
JCNyOQtCyjCbh72nYZ/SlwylkcFpLkOqQs3R53RqdNHw/a//DqGf5Cm+aKhtyiyWFO+dSP1UDb/1
jH4Ie7K3aYJHtxzN9Qwn1HzKDD8gcwQqNuzhXmiCeB9lBHWKsyXRU9e/bcx+DHuyl9NijY3TLKN4
sky/NmP213pkX8Me7W2a4BiydYQh6RltXjKnel7OS6BFGfMFQ62gjlYAwSMXz97jFuoyqTGs5435
iiGwANPaTAkWQlBvoe0Bhgji3rCw9DVDtVwWcLIwKhXIaKyfX3qXhi3gvmJoTtRYJTth5yM9oC2f
x9dpm8NWQV8wFNf1SAXFeKsr3MpaCj6y6cJ2e+btmkw4oLrVdefRw/jaaNp+FPsMDm7QRPQ1Q9Gi
yVxajEsDfJrSyVMnwwrxsH77cXMYl8p1BNoHrCe7ITmIvd2DWCEbDAt8Xzc0yQhWcCxm5/1Yn9kE
/lYtwtZZ36+IjEAjCTriSs5FJjdH/a2m+1vQiPuyoYNL3KdSjDiQ2M9LnMYPAJ+mYVPR1w0tA4lB
0MaLuzR7niPxAebj57D39gpDvC2TeHQQNi+zBnJprgZ314Dd+qv2o59sP9QrDfF0B36uhPQrm5a3
Nulq3EB3gXPFFw8dKaTTXQ014laK80ArUErDbNuYLx2C8WvUM0B0z3ZYkvvUlXFBWLf/Ij5/ktdS
b+ucwZ6dV+D3zjypWSEbS/+qEgWiHih9deCX9QK1diMMncAEQT/9KvIhW4Evy8wvfoGffVZvEwWP
+cBZEyqIuB3Yk4ngSYyGmbB2T0a9fdSIHT4jDsOD8tnDrulXOXR92Jv7OqKJpI1SE25ABz6KItbi
bmzMcgqKJl9JFOP+s5Mtktt9Sk9LXTYF0+kStjL6OiIOnIao42uHA3B/oGdOCv1UrlrDVkdfSdRN
09INCVBtzKlLXHUfgCcPakVivpDILgQEyOst5VwKnVeqM3m5h/mrMl9IpLu2Ilh0IciRO+Dy7TGd
JqFCv6gXqekWb8uaAYSRZlUhR/kSp2EX5izxApQMKA9rTVAuS8FaxcT8c50Dp4oXnt2wAiW/Qh7S
NWDOHW2jzy1w3kEXoOCG/ZgC7FU6yE1kWFkYkOs0Vg/R7MIML5gvJupbne0VidNzD6PpZ9ZX7jym
1RgW/b6eiCSTo3wjeHoyj3mslmczjO+Dgt+XEx09mKFwUk6hktu3++yYRa42NYblAL6eaOA1bWh3
TdHHb0kjf2tFGHuE+VqiYevTahiuquS9/APY+AmlszrMjIoRL9HF2bMbDpA+z1l1QCibqX18jNJN
fgobcy88pY06PeJ+CO2NELPEM7+FK5ANiyJfS2RT8N36crheIdAbGJae3S87QH+yf/omQKUVfYtb
MxxCHS+fjm7+Kmipw05FvpJoRnKhiUMuSt0QnWPjvk9mPsKC/x8KomWq5nLUKLI4qc5NOjRQb8gw
Zxfmi4j0sOlRCjy970C8b9h+JdeGtWezf2iI5trs+AelpwOgZ7B5v9B6CVLLMF9BZIzTEnxpfNA5
ftBD8oeodOCIX5PIv7V7EiCBJL/WEUlZvrs+OuXrJSh8fAcgWck+nges5PMmT8I2TxWzYdVPXz7U
0j6N+CpwNC+XudiQCsk2HsKW8djbOs3UueEY0GfT6+Zd2Q9P66/OcT/JzH2OWVVNMj2aA5m5ovEZ
eDr+1U0RqjlHvcqPYaPu75+mjKMIR6wzJA935UR1rlAHDXk29RVEUbx2Vnc1vmit59dWH+QGcqj+
F/nt9RLln2oZ6iuI+m7gtOxxOG/LrXns7Vh+5OMCgSUaLaI2l22SPbYZI983m9Kw4hT1lUVzVy5A
2FY4Wk/d43GtwZRwOfvFGn+taf/bb+SdT8eUgtGmsK2ieTj+2I0cUO1GihE9oRt82c7DuvEo78dj
MkVZZgyGhzSagiYC9cVHZu/kpERE4RZcZQUgq2/DzOkvvhX7yW92/fO/LRuxQkvx0uFb2ST9bMZZ
F4SUYdbP1Dc/om5smaxKet6mVedHxpJTK10WFN7UFyDhYj1S+45JzJv4hdkjuU33gQUtTNSXHsGd
eSvljFcf9vFusdB7liRo46W+7mjbetZHpLne+KDAhOm6vkIv3P7iFPWT4POlRyDpCWmbSZw3NDb0
ZyWI+BRrgyvfZVZAcmLLjIdL1rc77j1cJ8agrY36uqR4MhtYkSjhSMc4YCEsko8l6ac4bKL+Q5uE
+0iAPBAFabPYvLdkzSOiw9ZD3yXpkNMcZ2Wbnantko8Lc82LWsamCZupvjiJqrjSkcJkytK6mCpx
5JMlYVdl1NcmJXZO1qrCwLTr2pz2mt7bqg6rJqCS/ePykKaRbMWOhxPZDJc46v6Yjz1MN0R9dRLO
WNG4RNeFrRblTdu/TdT0QekQ9TVJC2Qltt6xHZRyejW6616IjkmQBo/6kqTpurirqgXGNF6Qe6bi
92sfzn9vzf+eWlBfkbQZsrc6ltD31YP7ChBRE+dIzAd6mm27f/jvH/KTVd+XJU3a1jqOMDo62t6Q
QM856UnQARco8R+nTDyhjWhfsCzH6aiLTkGY3Lc8cLb7wqQ07qTZJiyeKadVbuAgeRmTrvnF4P9s
XK4f5W+74UY7lc5AWCFzWb8mpX6ES3rY+uVbBcFRikYC9gnnZSMF3JefTcWCDv3UF8pkBHfOhmJM
jiNGcVhVCayIprAWJfCqfhyTmU0mMy1qW+1B11zgZE72MFov9bUy5ojjLm6glYnm6SP8DF9MFqlf
5Gw/+Za+VKYDLX4cXHctD+sIvaDirEr3q4LF/yoT/5IR+lyvQ81zoxYG9UM3iu7WVfGa5ZGsI3bT
tVP7ro/Lbs+NxApaiFplnyIoSJcT4XBCyIdO1+7kIIK7/v8gKF1WWya/8jAg5H9lsH95O18GV0lx
xNWCKw/0IInysZrSac6VaJIod7OrslyNXfpeVU7XBUkNN7e9oZuxN8kyu+XI7X7ADRfCqGYn+LMN
XR0NI/Wdctn+fVd9JnOop/WpqqS7W8yc7JeaR3o+2b2HGnkH4t7BZt3BLo6vUQ+PHaeyvExt92aO
JhVnuaqtOzXHUuoicX35lS+77U9K6/XTFltdPUF+mLm8FEM9FPu+uPfrvhzZ90R3ZQ0DrEaP973p
1pcdWD/23NRapI8w4zqqx4Ons3jQUV9XwNgeY/+G28dsfdjXxpguXwmfyyMX42g3gNBjAAGzbe5g
GwkAlNguQGsfGvpYQyAgpG053wLTqtWNWVEA+zztyS5v9l20STFOY1l9AsdxeNcZHPxeDsHbNtc0
7dW9jFkTP/fNSGghLarZj5Gpu/UdH4d+o3kNWxyOBYwYiaJoC1prV7S6pcujG+Wmfl9JQuxdtevU
ETSRpaN6jSgoO491cji4LhEXZ+bVMVdZXNsSyLTzxK0LeR1d3E93yOgrkXebEROIP+1+XECXBXT7
xMeync6srgz/fe6jdcjysXFJu5+mOJuEgOO5nlYQD1yn5bfVDiX5DtLCOHykGZRPj7bla/8SsSyS
D+Maye7FiWPBBxCLLl0OavPS8wLt+vtxfUlc43VFhq6G+uPSOG5eqoaLhhVsAHLL5t1MzPwIlkAq
3nQy4uLJTfoo69smxiijR0RVF1EfpbF5CpXX+8pxsr7MXYciRNbXS1Os3dpPf0qzlqM7z0MPb386
DtMDlM5ipsiuYYkZo915Wz70ZYN7BZg0teRjW9Y0OVlTidM42bg5RUdH8NU5i0Hp65mpi/hYmwPX
M938PGTJ8FwtisESserkl5IJW92nIhtx0pvKajzwC0VNi7PfwEyRiu46OPbGYBTIiZJ1nE6z5upz
fBgz3VDZRfeoSI4RyrR1F5/30bJ3ZOjI3SwWOhR9Z5okJ3vnsouhlRa5ZMBJ52JowciUjJcmX5YW
tekWeIcvnerXPReVqEjeRbiv0lM83ghAMi6wkMu+oPUbd7Z2PEzR17NqT6xcxz0norM3o13pb+uY
7jyfuLUaQmUl1hNYx5W7sZzRP9W8RCChNumHbJTGgArdHOWJZ6wyt2awuKVZxqPK44XLj3Tn06mX
6bpdJtid1M9bJaNLBLJDfwd54fRlGEh1r1xd/5FogrfSGnaFRbumK72bZanMexsB4VXUBJ46p6Pt
BpkT28nxddiFfm0N+uTzcS3Ju63Uoj5NTRyLU9qKBuS2ztwZedjX0kY4rO08KpfT3E/v22lIb/cM
hK3TRrN1vERdv9vLPJJ9PSN75jqH1Yb7a6x6Gj/FtTZ1DgXK0DxUncMdmkGD2HrXN9oUYxm1/S09
yn46Y8/dpyeogu96sY5/kaPC6HRVc5qipaqwzgz0Thsyv/U1w1/HjcUwFw3uiV5rdOOLPIl3/m5b
hkzfg7/EoQWomolfKNvEBz0Q7R7YZNEKVBu76otzh4oeTdu46Ra8me2hb4FLzoWFK1OxVDRZ3yW0
gcchHY720o37toH8HO/HJ9uL7SbDHcmjYnXTnwhFgzFnKGo8yiNt42JLd4NuSaOnxzZd0/77uLZ9
dqm4y7ZcajEmeWR6tb0OssZdSEWPDv9m6FjGDaAW5ExWXurT3vULFEGbVMd7w+uVnmAjjM662I3H
ewaXoAiICWn1FydnWGWDiLfQk+rr9amEuhcX3GLe2vO6J3QvhIIVVK5dqt2NaluwbXNOlzan6PR+
ILSml6Vrxje5g2W47qMYbwcNRe/9uO/7+G7telvizgki3/TVmr1xT9iLSv40zXL/tEtL1CU60Hh9
04gInguFHiiwaIDUpN+rLJ3QPy5jWqIdUGl53zqY8931cOfVOm+qgdqTm+GC9TQvSipgoUjcPGBG
DU+1UApt7WtX4fYVqJ7zPtRkfe2vlLQXyhtDC6ct+Z1lcJ5DOa+rYDF/9U35JGw21O0DrUTGT7DB
jEsF142ZnBQaIs6zqb43NprfULA/TmhGwUSvpRyKKIOXHY4HLHttcWf1OZ3M8k0e7TbkpHGZLEpZ
8jurqIUH/7o9sSl271XDRFqYEZaAVjf0YVqWpc/ZaroHVGyqYkYbXUFsG9+xqZcPmznm+LSKFCRD
gb/UfLFTbX9n6N99p42ttyZnpU3NiRnM+/cQiE3sdqRH3OdbNsX1pWm1bIpmbRd+GhKXfiGlTFFZ
j+btKBDVLMpN4gbyhqBy5WmTOhoeq/aoYaHXHOaip1KxG8isGptj6k0PLZvgiB4fpLmrKQDCRSQc
G3JY72W3pm6OuYAVxVjfCi2zJ1DkBpcbFbXbDa8bxe6pWoh1xbiN+7zmY7xP9MXqOmPF2gNYdJK6
rV7bwabDyU6x+lgl49TmcbnSuZiads57BxxYPqapXp+jRmauUJPUd6Zvu+5hy7KjvZkzHU3vk4Qc
roAcB9d9tEIKUold0YsQNjK3qmkyVH4c63L4/PzZkaXvLyPnzXSSvCL3ejONuhHg1wxns8bq1KZi
KihbkE5NmpvPC+jGSz5P2APynbRfWjHKB4WO8BxeuO8aPQBkq2iTYKVHC40+1RsR0yVBxpFvCMYy
pzvBJr3Eonne2rrLVazXGCzw5XbWOENkK8lyagjN8ZPMaZTly+bUb7sFNphunN5uahGowtgUd950
xj7mWAN3z2iDLv11jl3H70tX86pYNju5p/kYy6VIpwpAJTvUUXqhdkB7aYUWv8TlSGKq9Y7EfTYU
7dw1Ot+SY9MXK9J5eKZL7Vwxzx2tbs2h4Sm8KVln93OGfCQfBru473vScpmzowXab0ESvp6mchXt
aRiqJC4UQe4A//UtHj+Luoym00BE6U6mAqgTL7RNH1Ens6o4YD79iKQePfuUl8ufqxPwpzGsjFWx
asymhzQb5DMqskd5E3EkVzetmfj+UY5jyzGXkzUu+mreu3dDvdDfLLcJYmSPDDIUWUZDIWBB2+Fe
PDHqNE2weLuhEVwILrSUjNyBBdnKE6oOVfW+Qu9T/NxJfmQ50oHqtutJlGAEumR+FgkOGad6XUtZ
2FaSzy6LNo3am0p1fxs5UDbzXiFvLSRXHX1uoVCoC60m9N0s26RflmTGNWjNYOKQpwekerdc1rp9
GGpBPqI2v2QF1s3+JkuIeGm2PZ5PTWrV9P4g4/oe7x1/paKEKaKB6YG6iw+wUHKY1Irl27HsIjmD
5o063dbN635qMjVlb2guTsfbFF9fZ8WYEVl9dd0MMuqhcEubV1svP3JhtgamznUanyNAcVWxR3Pc
X6oe7ronN85uf4DHlBsLVvXJcGodnOwKJP3xo6r6bUH2O7X9Qwefq89wShFxbqyD9+Rg5w3Gopnd
/pBJv5EaIpN17W+nBQv07dTOvTlPo0Z3HN51keDLN7yGOBJb79nRIWpfsI7r7YNx6DF6OPYaZ9Vk
23V3t21cJqcxA7PpVG7kECcyJ4wVB0kHdqvWRGC9WZIalt3zvM+35EhxDFwb0I/f8M0pfwBJvBv/
sj220BuesmP4QydoLypoSqrt3c7rnbzSJXL1GTZBpTj1TdxdUnT7/GYSMj/XFHv/KSGD4zgtdDP6
Hyiaik8tG8rjJHvj3K2dtoaeBGv66E7WUNu9IhGlrgBoU42fRHdY+6Th9oaMa+k3lD7qebzEePJz
Xx5IMLuupu2nJuGde2x6nsnfopYz89uSdHH6QrZ5Fbc7EfTjQjm1mGetfTHLyNXtCL4PPyGtJroY
4Pffnzcn+6RA80Ms/6IU2kKTK3KskP3tLnqMsrSc75nFtUdxtENrETHWHPnQcAkFbwbJXXaPWS8x
/jDwiV5UXJbRO3ChkA40ZYQIwsdu6rRFOxW+04Xu8b7i6gTmZzlJZxejX4GNH9ncpph06BvfzBdr
XLN+kzChLL/NuiTHn3LBzJ2+JwkCNb6yGtsRR1Qp0rJwbRK7fM/MRs/TcEXEKSXXB6ensTm1G3av
XI8VDreVmtUfrEvT3zYAvK5VeVvFKXDxGSIAt0RrdXEd9sz9RCP8twQEQLt1eyjZOpj9HQHhst4L
uVC92BPWgrrHR3UCligNDk3mlDQTTi9zvSew5cMdpDzD5nfSJ6r0PhXgICRxDiVOZbEqbHAJWXDY
fls0ms5RhEZrYpedkDbGMHtPsxJi4Fws7c5+I0lDM2QahkQFq1tVvSxkpdVfWGaH/rRKzKVL7YZM
3Am+WNAWuNxG+eX/2PuyHctxa8tfMepddUVKlKiLWwaupDPGPGREZLwIkTFooEgNFElJX9/rVGXb
rsB1ux1P/dCGYTiReXQGUeTea68hqUaqb00FhOBWdXHfZppFqkSXURoECbcBNr8Y+2ixYYSUdQKC
1xSsF7itUX22IvfkjqqobnbEBna48nRAaG6xwzTHrhvcHQJQkdjaK1OFN30tLKpTYAX+u4GpG9nE
PqSFe5Ca7JqNKLntnV60b1O2StkeF+0Ku6s0CTDmWukHmD3OT11Xzi8+RAR33JQGchCv1yOcTU2g
8rYzYX8WO1e/K7UUuk81hbcYSvhOYBUSRByKrWv9uMG35PD61/2l7Hm3x0Noniq/LXgaWMP3NFr5
R+PHaFcjv41ZtmBYojeBqOP2YsJd6ZtUDAYodbpMsmvTtXEB7oRZ2TXSryF6W9ZwTn3c3tzpKbQ5
ZQO9jpKJqrMA47oAtQ+Ot7RsFRtB4GwNhfWwxqGH5Msk2NIBnqqbpKeBeJ1JqcwGvqI6RLxhRRI8
Wyiws74fMVeZPB/ikpm17IomiLe7ZkjM6rIAMLTKVjTJbV6vk67O1rlmGvtbWwUpyNIQidfoP6dD
AAP6i8WYskmRKuX4uQ6XET2U1wW1TpEqGz2yVvO3YPb86btPtJ6vqhhKvC1AXZjK0o4V+AqzYkgC
AzutyiIE0d/gEgM7t9zjE/YhQgx+crjIwU9YDo3Y+5GTCEw3vIuCDN4V5IH4QJ7SGVYTd4LEQGUQ
6VKg05yjjh9w3kBOGIIsdQCy3kUINhNBAjwHFgyZ7w1jDaoAtjkYvdgZbUDU+2E+FB14bEaWQ3E2
ErUiiZzEBc3Q4vFbVw1JnPqJ4yrrua6fIpiiHaauGGlWUsm/FYaDLT30SXU/lEP0KEwsWEZ8Ub9A
/rXeccRE4EM6HOjofMIktVWQXEe2qJ9j37Qk95xQB7zJch0sgbfBxipuRNlMFMXS7GRmCq53rJwn
/yCbBQzqkGNpZL1gCCxpLIKQtivKgHILM+2+xDlnkD7lCmyZR290XXVXnoi/z73oUeZQTGLCD8hy
y+pOgl6PEQ3BKQW8hqN1qAsAbZcimdpzvTB/0xgPNj41fo5hM46N4LcwxfVdFnsUu26BU0uZHONz
VuSjQXE/YIF5BFCa144pm4EiZetcSZhOAx1JWT1vRNJdUhYv3xwVZl+23F/OprJT46ue/QKHhZym
8ugtWkIF6fM6SGzaQFJzPftB0GaJGOSQQsDredfBsFQXU1BxPyunPj6sfPaKg1Yz/L87UZT1N1ki
Pe+64HVIUaMSO2emLssbP6ZIYEq0kZdM2wABJG3RLRczmupDMLjhbCloaDL0TnAZYgUO0gktmbhW
Ych/ENm2dS5iVCZpx+rkDri6OGIU3sPGytgRVaat5wdgNAoVtAehK1qbppvOvDGOMJgd3fLod84d
Cm9cg7RNiuayt538aEkcDwo4BMFuUSztKs+kRcN3ZkeeNKlZiZmzRczo85lqPZhDMdyzHW9aq6sU
Njp1cRezsudnXuPVx7YXrcvGUMzekRbG9Pg14+kdIYKiTJmZqjgla7gMuxAmU98Nn2eboY4rrmrq
6HlYJDfGVCCPwvCOzzm2zfVCB3VPz1sMud8hpI9vOAwIvi8czcVRVaQt9iNpfbbzw2gxO8S8jFM6
Da6+ZZAn3oRTUQ3pWMTLd8gW4yeqnDqKKVAbX9ntUgFrYerVBXgk0lBr94T5QZiCHYNqDdN67Jyd
f1miv7wKgH8jO0uDIrCxKJ8eKrLOhwFn5w00NNo7yGgGRNpGhbuBucl6tDpmdboUSXss+91rv7p0
WpB0Noe+y+PdlMBaIotOSHBFmvKOtmX1RDgWV81rBe5SyMwO2ZGQ5Y2gL/bZJAVuRYMYosulbOll
VK7LSwGQ75tkhb5a+mQi+0SRh8Rf0sWNH6y092vbEgDLU1keG7aKHpAfq87YUFUH3Bgv7TVCVsCj
cXLJJz06meLnZ98Kb51tHqF4HjPjtTW4QsDYPoIVBnN4GgJg0EhyTG4TNM1XdWL4lRc0UuPUWUqd
EixbPKd6aW8a3812u/ZBKDZVvQB3tX44fEeKi09xcgcB0Hnp3ZDEmw4k8CdEuxROvYZsXd75Ynsf
AOTCBhwJkn8oOKG9hcw2eGk0WJEV2HcL4B6A5oFEVvSOlgCoIbFz5vtAlaSpUwHMDNpxnIq8S+Jm
TGnJihnF4TKfm3mum4wBn78HCyaY4cTjqRJNqXbPgAh7tbXRwN/xYNF9FK2XygvkZdIQcRGsoxVp
1AfmaoiS8gLbdfxDSISR/wvWxT8ZNn22BoCv86R7VoMWH1t6gHZ1yQIQo77GH4g/EdlaH9AGFQqM
ESxxz6Lcaqn3/Wuj4E8k8LLu68E2p+EhafaNxXZEqPsalxKB0n+eHQ42rDuN0ODNPJ/WT4/k8Ho1
3pe0CMFn3TcJuqUqcIxu4LVJ+L6O/PVINSahX+I9Bp+F32CrNwC8Qal0Lrr1i3OaNE9f+tE/i76X
pQHUUq1gXYU6Xcvo2ovo11biZ8U3hksQfCislbIsfvROficj/1fEvn+yyj9Lvo2K2yKocG1WFo+a
r1kTfy2CL/gs+K513bJmxrS28tQzk5hjlfb5Sz/2Z8E3CFhLAGcAGJopJDkwFwUYgr5/7dqfiIHB
NFQJukKIsiV9XzFgSQYyf22A/VnwjdERBDHDSZ4Zez8QEjflpGzDr5HQPgu+0dnMMmAQaML9pskb
NNAPGKENX2MksE+0oSBcACDq0yI0pDgngCr6YP3qxT/thhV2cSdFBzKm0ZfR0mS011+yjwk+B0XA
KxLAewTxVDjND4AWkaBePX5tpXyi8/IJszIPap5NMS7BdS2qMHVrab62oXyWfWMsGiVrVUFl72GU
4wbvEDfV1xyYgs+6b+Z8P4n8HsZdAbBZzC5AXUBf/aXf5bPu25ZzEa+w7wL1LnmwA2ZSAOi+eO1P
T6ec4cwPpBv0kpHu29hsWkW+dvZ81n3baB2KmONjA8vdOtU8J6J7+dov8unQHGGfGbGTsV4cmDVz
gVj2tdZr/rWrf3o0+QJiQVnA3rExiUZg+JgThFL8ixPzxPH6H3gnn2XfDDgOLHuhhWmdQe1YBgWC
VEd/Bu0i6DEXBqzViH4vIzL/jND6j9f5P8v37vqPq+u//hf+/Nr1wAyQzfTpj3+97yT++1+n1/zt
3/z5FX/dvXeXL/Jdf/5Hf3oNrvvzffOX6eVPf0DkLliyNxgGL7fvGimIv18fn/D0L/9v//Iv779f
5X7p33/75bUzajpdraw79cvPvzq8/fYLOW2b//GP1//5l6cv8NsvFy8LEg5xTv1xsb+94v1FT7/9
ErJfaZKwII5AcEgQIIq1795//o1POA38EIzLANgl9k8FZnf12y8eob9GQcTwSoCanAWnEB7doc37
4+8SYJuhj1of+kkOj9r//dn+dHf+frf+ooy87tD86N9+OT16f18hpzeOYlC2/YQkPsE3/cQS9AZi
gUbNPO0CmPU0jATnJqoE/AaD12ICo+offpqfb/+Pb/fniuX0dphPBnEAIihJuP+ZrhXOMJMpTJ9g
XHaCbJaoTwug3v+iPv9dM/Xnb4W3AYWLxAlPUO5+4g9WrbdiTAAdCBkSGIbboTyKwp+BKdXotaHC
3RdaK3RcS0AuyVJXYDCCFP8vvuvpXT5/ioiFJCI0wtf97GAAiwHfzL1LUtmP3Y+m9cubVezWpmg+
uq5jbxre2gDkWn1EW6HSlVR223hqHDdqFP21suv62AwRFBRIHRM7RYj4EDHtbwcr2e2EUOds7SZx
XmtvAPGjazGS93wSZbEWKa+Sgm/NPIaH0iINNBu9rsmGyi8E6LIQaMP/2X/jSFoO8whGlgr8Wb3t
SmqeK6Xc8zou12HSF5dR3xIIdatum3Dp7gEmqYx4gNelxawiIyByVH/cv39rD7moX8dOdx/T5x3i
T5vKVf+u7qbx/X26eOk//8v/B/eSEx3/n28l2BTHssbx9Pet5PSCnztJ9GtMk5Di4YGxWIQ0gb/t
JP6vPvHRxmJXQCKAf/Ku/bmThMGvjGO799E1MZiUnjTuPzeSkPzqs4RR4GcnzBC8j39nH8FH+dNq
h9NpGOB/kFgbAUmi0WfBA/DfJLYgLmxWPg1i16K3slvIO6MHINTI0qjgyqCzobRBhIHZOH+jtuUv
+MTzoeAnnpVdo6pKwcgEEQFQPTVHH5h+e4bMsOQJu0bdppg7JwKklESwnTr5f2KoYO3VTGME38Ji
E5pVWWr+jHlSYFKNjoMBbR2KCwVLxgmwLjgVaRV3XpdJEQOvF8BZzmHBCZIJJwYYcUysuHK2aPa1
9ZPzGADIeYnpEJhIrBk+ul65vPEq/2VdFxCfx5qL712i2iCNEcYLyWxb+Zd1Lebv02Djb4mSDkBV
UTWgZzVVgiHXUsIIANYXsU5dK9cQ4LjUL3CWIW+VkgQ7wlrLRwoJIYDsBe+dApcGz2ImdihyXmlZ
pWQaxRNsytczBXv46OBh4rirSXtFw5EPmXHJeIRXhRQ7qZV3iXE4qIRJ1zRvVSO8JY3CEBydqE98
8MWmGEFybtEnvBbjoIzRybVZOHrW5iyA5imdChXUaehxmiAPMggwHVMGME+kgv4Co/rSpr1n6DN4
KshZ7KJ2vIlhKettAu13T820YhzrixBD+YFO/GoEM9PL2hKMwmyQej5he9KnG88Lx8egY8mPdrbC
T4dAlCDdS0derEfImJWV5EUuKjcdLZIXo32BcaKPkqaR4M9SNZkUBhcDT2Np1msEs2MWA0qe6/fg
OjY6LWOAN1vPKbq3c+doHvmu5VmHQfE3nvgKG1sFw+B0BliLHXTCyZCrWNXezsxJ7OUhXP+HI3Ir
F7wRw8wghT//ILO+AzydWRxsdD8N7bCdQ7DjU98PuEVGX4WLjfXIyzRpRnrH3YSp3IzJh8Ib387F
XEF7ThXoVlGANVaWNUaGMRwevs1iXAH0xg1Qb5IYGR3XSjUmwxArfGnLBSOCIo7is4GbYtwsGETK
jPICNBkWsVhuYPEZ1Fm1ehyh0V0kstDFfElpXxCSFq0XcUT86nXdN8NSgK9Sg/ey7zgk/BkM0xRP
KzCka0ThkPlZQXX6vfcoRofhxFv8PjrUUVqA+4X/37pl6y9j8mNcJ1xpgN44rZZ+vFgDRRhIH42/
n6RtxQbsXzy3QTQ7miZRFVcbsEKXDzGT+nts1gFzZTuBMto0I1sOVZTULEt8bBEI2hzGD1hdtkBR
Oy8UYHELUubI/8K3wUyzQ8pAXbDHWHZKgKEzN006JeGAHzMMxwet6vajtc57lho6jtSNffE+9aBM
pXgC3SWzdMXQuEcBA/prJ0kmxmaQqUjGFgzomlSPYDJRh1ZgQExfPFc+SFrTiQ8janIK626btsz1
GjYsawmo39lCFMbloOLFXqbAKIqPKpwGmobg2VUZZslzi8AydNE7lnjrNZ8XV2dAmqXMfQ4mD8hN
vRnTmHuqyFWlMfKINHfNbqrHBkOllodgpq4dddvFK7E1RWB8B/slETU4zQtMY9OgDMd2M4J+HWZ1
2Ms+W3vnjdtqbWK7LYa5Tba+FeETfCGHMIOfZf2AJjl5g+7VPKF+DjHs9Gttd7CMBhsJVep0D3PX
qM4wyxDR3kD4pDbBYjTZFh64VFu1ECD30LcFzSs+zmwOdSTreQszjvB5TkIDcxvktt1WsSirjew9
6/ZjZ9Zgh3k9mW7BGcMK8QBgR9fgu4GpNfmYrKfKJyEmvYgA7fNY6vYNgYwa2NeQbBuJyOq+L2+S
JpixC4PdQLKqiyXkdmh0VJQkKSt8lo1rjfsanFBQcEXAPGFNkUZM7uq5C8/XTl00joZQBhQHhnuP
kcIZx/w/oQGs8hewlsGjIdJcijLIIzzHsrdX4eC/6r6+8ZmwadCAMjaaXYDpe14ULkWIxLS3woFJ
pM7A2sEmIJs0SNYr3Q8QQ5T9mR7ZE0y03hat7mYR4Cntt5bQF1Je22m4kEjoSetlH+jqoKfm0JfJ
ZrESzwM2rLK9mutlI4fqacRcNp/YMOzj0d2DYEDqtKnnfRC1JlPq1iLVF8AYwwCNXygQr7MWLaKP
uWRsXjnYyxiidSAV4N1Qq+4ayGqlK/gxCZpHtgTVFhXjab7X5hQW+R7obk4EYb6KNtfBcqzXXhxD
HXhHLs19KUCoY6EGudt1eyf2tJN4VKHiFOVSppXi+7GU25bbW00gXoiSY0J6bD5NmYXzj9X6U6Zc
vBzw+sdiLB8xl9ZpocK7VtRHC8CTi+Bc2MWeSMMJNttlZ4fZTz244Wz7Mryp2vmVeY3aSFvpJHOM
2Dhlo35Qfgn5JZ7Ucdp4Id1WKMPFvJ41vX88IROOeIhEUSCjsfDKVA6rBlsOAmQOZaHRsXA+PKGa
zsGNe++iZDP47d40dO8v/KHX4OpGazVmi+TiAdnAmR/1V5rWG1IHGIxxeYHNKEijWdYbkDa7TbU6
EK0xgIq7CeF05FTKtNNr3dHbcZA8M3gaM7P6eey126Eb7i1tnrCfZixKqoOn6I11PrJhpg6bQI3Z
WThg5LpF8XM3xN3ZMLQvtK0eZ7RzKLkJQVxKtTVMtmkUcDQn4HinHp8vtPNN3iRVBn3AfGMrXLPH
AwR4D2NBPI40PJNmfOWh12RdbMmFI2RJp/kp7FuFVR294+1ycPsvqxqxzvkEClOOGRuKNEnAz4bD
BdhOO456I6e997Z6LFe926wIozgifKm/02GM2oSuICp6R09chw0m/Sq4bXxwPqBYrkFwA0caNUv4
3Yx2PV9FmYsBjKIW3FKwnG9o6LayqXKiML5SHPewUeE1aMi7cbwElF0eohA8qlVkoPEexlYl+OXr
H2uNDB85pUjFyIK5vPQidsDQ8TqemgwVRp3NvZ8rGdxRppYMTL+cRiWIg4Cyqn4FbaT3ynQBET71
h4mCgVvQdBJyf2I4UU9cLGN5JkR0TYm8VXGR6lggN8DuSj+5pjho4EeXCkI02ANinwxYbMmwK5cc
lkNp0D5Xgm69UX9DlfFUK5QR1avq+XnY3tTLJRLksJy7O7MExwjNdMrsC6pAL6vhQh609T7AXP3a
lA+YhGcxGbfFOG1N8uZB8bFEDXhsRXGBFKAzf2q2HqizGYey1NB3h2klxsdkM1RiSHUFnQgOmX6n
V7pCY2/2pIR9sLJ+Dv41OCW1ei6S7joEsYrsigBaBIwr81JEydY6ccUsDukk2ra6wM5M11cMPesT
L2LNCQb46TKiGvHX6U3patu53kKWBCKKU+E+ieSlY/pMzSB+iRbbCZgd0lVjjq8Gb0AnkhT8ihfU
1nafdC8zBeMcHB+ExqdIAq+e4wk36FCufvwWtNMVgf9MhcZgmjjmHD7V6aw5iI2dMOOyHyMpnhNf
YGzYnBQN27FL5k0NaXKVw77OuWwqjLeVosFZoHtTX4bWaYmcgzoEBTaS4evIGvlC4EBnYbwYFT38
qAqMsIteSsTnIC4GtRaYmmNuQSnZM8T0ghsK283baoppnIbg2Z/1XJIu9WYdHNHCmHf8tsIeKFJx
azTshWuwKHl005QSbARGkjWVmBHfxR5vT1vi4Mp0nkv1AKZTZc+9GfXVVVTU03WcWNjW6daGdz0t
oX/u+iRsQUuWITJmlrl/w6Plr+k8tqO/lTZewWpRZgERmOOL5X08FW1GcDTcOEe1zgi4lFet19tp
I8mYgGE4ydntcfRAE7LAcR8EFzCS8QEVKqSj30chjkVOT5UlTCiiYydq79GtnXeJygThs8CFBPwj
lviNTBGOmb43k0xnr1l//N5e/3+g4RfwLf9PSMPdi3mr//Lf48uPP8MNv7/sD7yBsV8j/CdOfsKT
J1HjH8hlEP6K6B0SAz4AfEhADv4b3hDQXwmjQcx9TmmM7hBj7J94A4l+hYr6hGmywPdpEvw7cANo
DZ/gBsI4tgXU4qBPxZx+dh4toSNqNQFU0A6k83ZFWcr3OgTxK1djzI4zI3VORyhxM+pRH0VbMC0P
aNoh7rKNNyQ4lmX7McId9Q7qSQlyXjg1e8Nps6PVCgDN8ytwJGKHbqZOymHfhyUIhs0ydCltxvKN
qXI4cO19U5AbZiP2jzMil8kH4aAYH+tmAKMTreNbwUP/Nu4V2To2w2KQku+Bg8EOzpsmTbhx7b6C
Xk4f+lGU2Lra6PtSCpAfwUq85WRRDQAAIVA2hUuGW3KOz43tNiE8HLOxp+yjnBSUiC2sXfLB4Lhj
BTBDSOPDrC8CdwN4uQHdHHLTOguKzu50aA2Y50kV7hY9oeaoZoScgSq9ShSXAzCJs0LPcXAUyJut
gSSOzR3GANTuAjcvqL11IaaLSswQYwaaXjReL1bQSWL25E9xDWSHmVEd1gLgDUhK+r0AA3gH+qqv
cKJV6PdbOrTf5qqrNch7SRXcSeh5gMoqNRQCB0MnkHAtrTCtfFB6WBKbF6DkRage+BoW93blcCrN
IZQbCBh2FmxY++EqkBuAP1CfgzxaZiAOFsR7J0nnmWs6MCajBDesBIihIEHuRi+X48h7/2KWjAuZ
lWtTl5e1Z5Amm2F5ex20U8htMUKEGSUqQRXDOeh6qzVjnfsmLMqMKt+8OeehDpVYQRdtw/R4cINJ
osxCasTP+aqpgO7H2mLjkTl6LBgvvVRHfLD5sM5g/jjHkxdj2ErAUhPJWTxadtJ4TuHKsQ/jsN1C
myX9rZ1NWWPJU5QKJqCgrYZtaG+jUILUGkpA4d8ZSFYbtv4ue0aRlDwmkI7dg0jWAcptKgMq+SRu
4mhG5U0AN7ODA7VVPziPRw/FmgAj8lUQXg2d7Z/Bqlf1boWeIQWhoS2zYU4Sl2GQxK45LNdEZnoP
2fLRSUr9TbtYoAo3aF0zFyv3Go3gjmYCsPuSd23MX/VQoYuKezpVZwWdVweB08jWbGKehsLLifVp
AlZ5Ab2WLs9W6voWam4BLm4816ihEWqzmhxsI3fFK1AE97bvFxTVsMXfBvEy3vTS0G8MSeleXtTD
8l0Zi/e2ilddpoURKEVksmEC4M6RcLhGqHWGKKBgNrgfarCLM8tJ8q2pVtpswPyuDmOHCjB34IsX
GZQxw7xZS6hmX3yIDd0GAitQbCu4IPZHYGuD3muJfK9sagO/gUp16q84Kfwhn1dPrPeq6iuKzhxr
8SRMJOGV7GozAegL4rdxRrxp5rV2KXMKdOLetA2ovD2vIzCpjaxQEA5xLREiENltTSh0D4VMEonQ
P+ie055E1Qv8pMJ9R1x1FQPLDLdSeeJ7YYJm0alKQk9njlDclII4fVb2IR5/qCzC9xWsrGuE79Fj
wsAwT7tyaD5iPvsG3OoOPPopoYvJ4rWCBKoCt607LjPp86X0xyifdSz30jd9ly8dig7uLfRpXaNS
ptPKu0cK6Pj7TMwEDfAY1SUK9MUNaLAKAGcO6T9AEGH0OqV4NTCBYIYhVaZqtPvLAG31mQj6Il/L
crhaTZQ8ethY+9QleIa21RTKAzjuSb3lA4y0M2mRN4nONQEPc2igwuyAL1olt4NENm1KYd+loEzz
SuAKIRpeZae1rM8C3ZXxgQ5JB4KmV4ctVGYe5WpKrSqwfNDRu6KI8tpDT7Od7Aj00iukb720dgsZ
SYoJ4Dq6zPN9G533XdRAVlRigkeAIZUnbtyAxr2mQwDsxFBfe9yih+x6SDnSoVy8or+OHaZxoU0H
JgcLPazDCKlHhdW7NYwui9BHfwpgUflYHQM4/hjueqFXeehfiQGYAHF5LHNwaoHmqrCcZ4CobBjF
oWEevP8ojkVyrnw1U39TG4LrbqrS+g6tI8DbFNuOqXLKZLw0aStKOUP4Bm5rkfqjKWILo4FyNmZj
qjhwZ5KhnxuhbRPRLK69cC04A5yVyGHTaOK9gtcN8+jRlfNwHja4oZ5S5BlQ9CLulhjBFTnjZkny
ko/qrganGpLtyvhT6iRbogyiKljEN7wrzXkRQKu5P8lOoI2atUbFq/S9NyfTvJkwL8H4a+zleyWr
ttwWBDYLGTR1w5J1wUyf+7aq1nvPQY+KVl6uYOgrSKFzqcMivqICTNmzMqSwSWlAa+Z4LCpUq7wu
ZIVb0MZRlHFP02k3QJKPXwbPIByDteSWPWEU13vVqXtZp6tpNaQ9cdN94HqNdHoLUxBZB5kbFOjD
ZYPtOKDVFB2CdYnkeQU9wGGpsZGcO2kQyUYorrnufECV0PJHw0yvgfLAFn6GWbHYntw/UfLPJQly
Wlv6XOoALA0okHtIlEbe6EsXJWLP3cKvJnyj5KHkpuPYVJAOdNm2hQ2PAHFwQolReBba3BBKvys4
UDoo153PrqD7E0O2ouCGNPQ07nzVpCi7DJiO+w4XTJi7SoMWmVlvuWN9USArMcS2OWKKGmJKQhuY
CYC7iHEAQeQBLKKSMOyeuxiSRRg71GXWKwHnpQUWndEBiNRQ3yR9pe4gQ6fswWvmePEzeOK39Iid
A54k7RC5qc1KkowfYYcv9dBxqZJNhzA/KM8xbWIFLA64hh4Adnb+Diq0dt1yLbRAq6adlVmNJ6Ke
gXeFQ3AsQ7957Vsb9RtuyxUTIazF5dpK5Cg/m2ltn5sIusrs5JCxpo3sTvcUko5+06HkrQ9LYDW7
L5XHeplKxia5RW0I1wU5m3nbTxW4VqBCRustQOCS3NdL5TebdQCRFuhfMtBnRSujr+XC1PXUz/Fz
Aw/9Ae5sSFvZmanGUlEEiMiGubC3UCdJ+MH1anUzAuOIrO2zaXwGBHvQLdsuPIFUtBo9gFRWxB66
Lb9cQKlugvapwNr2L2QFrzz4HRRrBWuDHiYDPOpxFERr3Mg4RQArviKUdSZKmU5GC5Usgyyv9pZw
i7qrugCvnD6qdm6uKPHkPYfp9wKyPUEMCkjjmFzoyKIKx8RkvPE71MO6WjDti7gFODG0YTDkC3D0
Rz8B4A4lkzEmXxyLPbjZiEhcCdZP4goEBQAnCFtI9mu9ePqI9rDJILKf6+3c+uZYaJ+/FL1WNvPY
wJ+HEo4AucSiie48q6XIfbj+CUAxi9minG0/oqkv92jXS6xmE+qPzmfzt95YsrOFH1d7mNz3tyse
1QXiNKAKbR1j64zwFQ4lBpQbCD/8m2JczdXoEf0GBw0MnIhfY1Z4qh0zyNfhVBHSIJyyTiG3NoV5
NlY9LyOAH7qrATzrxGG6FXlqheOLXYsy2nIMcSG0CsHiTiFqqN6kgFvjlrUCCnsaVgwnrZQ6OQwY
lz51nmjOuskGGGEVvpsysXYcgc3Cn1+A2i9hCkJYhTkd6kUMinQLMHwhxRif86irLjxSkC7rgDKT
VDPp42joTHyNKj15kWDwbZt5wpKYgqLW6UINnpegCWcHiWdt7wFPxma/AoCHDMZg44GbV7OnWHRY
/BWEK5t4GucfAv5B3UFahq1Pw0xs2ELCFwOrY6AgHaf5f7F3HsuRI9m2/Zc3RxmEO8TwBRCSIkkm
VeYEVikIOLRWX38Xsm+/Lgark807u2bPrAZZlgIMBOB+/Jy91+6NfDtWTlxu6omFffOX0+vf6Ep+
IXj/pbWgKWJhZrQNj5gZsUpjmHP/lRi1ZGuRPmq5L6elagOnbpl0YDb1Ls1pLDXII2U/bEKMzONa
Y/C4G7VtLX7MrP0eH35cvaNBOR+Hrz+QZE6PU5g5n3MOPsPblpV1URX+NGVcM11k9JnMd+xsWZwx
V7PBswzUzjeW6srDQqkxvnNPXmttft0Sx/EMjvSGwI1wnlrC9l0vzIFKjFh6eN1qudjhLWhffn/n
314FcysHcFfagFbsc7x4l2hlmCEv95mHix2mzuRQhHN0+/GrWBKGiLB4b/Tzq6RGXNLyp4ZHf7Ac
OZ4ICo2weEdE+Fqws94x1DqeYdC8sD3bOecZywlvWJtgHdNtTs8so6bpcnao54dkxi2//+hnchyE
F9w+OiU2/9TrR5YM8NDucG1QFnm8NLMU01YPq+G97MjXEq/1U7mrUMyxXdRbtPTProMZpGfT4UkM
w2JIdqUmqRrDuek3ulUV29TqVHj8/Udb/8nXb6Pr6DbtXQ+wlsWp8/VH89BlscGtrWS7aF8aZVs3
Mo6HCz3u7XuAPvl3Fv1VjsX7+M5791ryyKdd11rDpAdluHJ9XF5fOhXGZEqDlmUqPHZNXPbdy4R0
lndu0lm9Ot1zpnX0swzvfJ9vnh5uMoI9h9ssdQ5XZ1cubZ2MqlnQR8DLxUqNuY5WUZsztmiixHxH
RX+mcfv1QSUKQL5PPDaOef5KmJWqMJu61DaDxbbTeRMbQ5LN8wMgWcosru/chjKWj25NnOBeNk54
rapUPf/+u37zeAlTssgZBjJCzzHPuZdYexPT0mTuJx1KRvr1C0cIo6GW8vU6ReQvM/vdZ/pvvmWb
VdViss+SL8+faRie+ZK62C1lJ+VjXjpGZPgq8WQeZIU+RDCr3CVBTdR4Uf4OWfXN9yx1S19FVev7
xIt7piAH4rGegWM4YYMTXuhyiUsOhW77EjEQei+y5ezuWiiqDJ13CQmhzeXOw9Tn1u71CeSbn3E+
vej7AYBs7dpfsjZNgsalM/jO+3O2nq8XZKtgqTUNZKYIhV+/P5WXdLHZl8ovO4d+aCKHAI7He+v5
m49lm47DO7q2g3WLBff1VaSrsrjytNhnSlZtG8xhwYK/Fc7FaCYHW5/e26bOHhj61FxwvRwPq+Pa
54utTURvOYSV8pvIMr9mHFifJhY/OiYy6CP6QPEw86L+/tU4e1K4KCJ9ThwGVCUqgfMVoZVOMyZz
FdGMHX+EtGB8r+x/MPGY3vnS/uZC0nQAjvEfe8q50jSelVGZDZPzmddik6EMwpuI6igx04+FIPHG
2ZZtG2g9LC7o4ch8/c2N+ojqiEPAZgqrJPj1oTLK0wCRwHuXMtZ/6y/byHotF6kzrCW6reuq/vpa
WWijmbFg9VYWn8ioksKl4Tl2w1VSyyU5hYsT3VrQGq6hxrEGGnLpIt+dcoAwg8js7KoypmzcfvRb
JUfNFpLHFjm3fe7sKroB9n6raBEvHOtCvUk3udsnW2/91ccvZfHkcESmSHhzs9WSxQzrI8Rt9fDg
9OMD9OUHBBsPH78MpSJ7l2HYhnv+iRJIVFURr8gpA3N8AYdgKxJXkG+FdOjjl3IZA60QCId7ePaV
ql53IBS6kc/ElEm6WsJrl8LHV+uvfn+pt6+8QPQKpx0NuGnw5L5+emiwZGmDyQIiDXJOus2839PQ
L8c8ZY1hvhFdreyC77+/6lndzzNLsb0aLFwGU3yYs5VtKFItTKw28lnhvNLXOWsyu+77T17b8ZzG
8fi0qKY/It2a/c6t83cq5bdLARpgYa4yXOD71MqvPzWH5dGtNWvd/4fKvHH0zPxaZmttgESKH+j3
n/bt1VZxsbRX+bHHdc8KPYAeVe85tbapm/lByzUa33b38B+sBW8vtPoGqKwEk0MPa8Trj2UkoxsN
8Uyjc5l+vQkMzv5HbwIppSa2HspxVzfP715XlZOyZc+cw16GQPEdPdZTPzC24lcfvXU2dbng7vFx
3pYwI+KDyDIqbl2bnNZ3O9fV6X/ybvMgCMpF8ldZsd94lqWkAq6Zk7oiLi/ot/7ILVFc4Er78fvP
86ZwsB3qbcpAnjnKo3MYt4TC1CSgF1ZCbXIQchyC9z/N31wES4drG9Ta7tuLdE4+qxIWC3LPovgM
OaR94Y0Suw9/FHc9M9vAYZmOnlcn+Vgih20hjqSDFd2yvxQXdde/VwO9faSd9X6ZGF8tFopzkwr1
LYKRGCO+WdqmFQg+27AH3Ub57KVwzT/8qnINsZatDqWINNcf5y9M7RBxITgHWqWwiOeHbJyWYz3T
GMhsZ9r+/v793SfDAEAlyWEapfHZywr5cjYYDWibJk/DiawJVV7oKQf3slaus/n9xd48ErQfDMPB
D4Fq8+1ZMyU0babprQGc0hF3c/4juJuH74NXoWoUiCFYGHgesFK8vnvaAoJGcJmNWh+3lo5rAJHn
wzeOq3DT6P6t2zF71uur9FUyaNDaw03EoX089LproOWxcueOWlLU77Q73hThXA0RB4vQr+fivGqc
eqt1YSmHzDNS9WhZJdoF3arvZgPlf5jY0Ycw/WzAXM8zXfQk7BTUdWdbkw77u2ak7oG7oaWM1X4A
Mukmhw9/U1zHwm6Ft856UzOFHG3KpC7DDS6wcL7Q84njoBtOIDY++uTxRdEqcqnP6BvJ83CtGZBi
JdTIG5XXPfzsyQTflQAdbt650C9r/KtCmCutlZlHh4r14vy5aCPweFrMu5uta/fgpdOVCkPzW44a
4bJqLSCr41iVnyqPYacmhJXhUZ8T9B2NnrikIRHniF6fWhU5pa5d6DAML9E3tPSyQVZtDWfur3sE
m18l5CbNT+OsvXaMfHmMvZneAW3G+cEWXVld1KAk051TJ5w8R0eoW0badFa7CG7MJk7tOjqmYGDC
A/PLpxpYZ3LKQxl9aWU3xTtzPWU9TGMTXtNTbwFm1RI8jISV/TAulRtdtyQIiQ1jQOsGXKS7BC2C
hktvMkiuARwXJltRWkj2+WK8nwtZ1Yi0DYGXI2rs6bBEIHSvO9UaX3HrU+64Tk/T56NP2Ope5EhO
727tw5w9x23mQvCD6kqcJzVsC+GcwdO7z/Hbt9P9tZcyXaShjXH89VoQcjt022R7EG5JO8nKpvC6
8HpqyFELMS1WyztNu/OF1IJBLU1EVRBsOAucd85KaMO0iMhPIh2tfZm8XJAFMkQfQhHQFcf0Sl1u
s8Kx971p1AP6VYtE7rFpJotSXFFmLVLLP//+KzrfgbiKh8aM3iMLAS25s+U6zJTZt3gdmd335UXS
VtGqIMZDtsntdw8af3PjOKHxglL6UwiflwtpggaUSDmY/qMmNmXOthAxuPzHIvAhreJ/YKz+z3yT
/4vs1yvu5d9bJkFifMNyov7qmVz/xn97Jq0/xFodsMVZVCJ0hv+pYcT9yAPId0WDgZ7Qr/nMf3sm
DfMPh6+RgyPPKcZJg134nxpG/Q9KJwSPvzpjjArER0SMb54bYBAGCwjHJxopb5JZ0aVFfYLgd1Mb
Y3Sw4esCZ829d9rSf3sVl6qcWhPX6HmOYp2oxRtnrgLheb4kMi9+zIzGfGeLYplgPfrrHiUsKJAY
VLk/8JSp/l6vVxnBbMDP7ZUWjvJg08XNbARVFbo3bs9wfj+nkN5qKOboiHll/ajqkiHwxABJ0rNb
Y9PBxLxHFqTsbc56WF4NYWRapzrVEcRYUTM5uyJFd7JVRUliMAgrRBpN0U9tMEmzP4rECNVhWaZ+
bzgLcsMgYh7dM+uY6A8HDFZIttD7UN4ppIj1ReRVVkhrLgEiWQkR3QKBk8VBp8faBY4qbGNrh5P1
XXhL6x7E1Bl7yFuMTTK3AIqu9WnyKSxXLwei8OliZO++kw4Usk96OemPs0lwDXP2JH0YhtzTtzB1
y2thomXYrcHtxU5L8qnd112YMxrt9WXYMHQt8QqSHcbEMBykiwZeX9FhHLdok4KJFDUxtTDbDlMY
h48FvTAXwyaKwn0FMLeCjQaibo9TkM4NHP9iuNCkAlHXcTYsMAHN0bExx6W7HGUuxJ8Ct2UeIJcp
i8eiAbPZkKZY48aCb8jkO282EIbBlWbe3GHMM2clGWYU9Z9JFXp/tpU3PRRuU70MSA9zfqfLvkaD
mX1Vei+/D0wmXqgEZfFFc8Klxq82DVDqC910D0S0NHIjE61XYHiNkQQAd6ySQ2XiLb8DTE4qiDSz
IdlEtdvWF3oyNSRpGFOVBljukZd0jSaKoKTsivl4nYi2wsgmc493AlnTTOM5genUeyblxZRMx8YO
B7UDGqA7vgWxUU+RZRnjs4te0djERHdUhxpN4ye5RMM/KFAfWrz/s5X5f5ujnf7Xv1+d/28Rldkr
Pzt//B9Lsyn+oM5Yx5GSswBPLL/zD3m5YfxhsyqSkIe8mz+zOsn/CcYQf1h0uL2ViwGOeV3S/9/a
rBnuHxhqyYkhb5oCjdX+I4vzLxTFv9YzBOx0tKghEI9xjKCcWNuLfzkvl7HeMWZ2dk5idvq+yRYP
x1TOVt9ne9fK9BuSLuVnNCOJDNAydcdJ86TmIyCcf0SaDY2+iN38z3rGz78hTmV6Zm5ETg7Cqa+4
Kk2YwSPNwAb/ovCx9Y3XorNj9yLruyb3hTfYMJLzRvtOvmLcIGBIvAlpWVFAcdAc6W0IBYIXm6W9
9zmR02oTpSs4QVcusZ0MLNDWHux65D3pSisc8BK9uEddrDc7kcbhS5RilAtWjd+8NbJ+RBHfZuoR
JlpdbhVGMo9zYZXcOxIbnu9pEvZ8mWWZTue/75NggCeTsPKmrvDp85bg1Ktahz9aGN2jGFU0ncjL
KPJt23K+RODIUtMh4x3H6EpLm2zvgJIsp2Cc3WohDkgzE4UZFMDty18eub/RhrzemPgi6XUw8EFR
Q6PNYkTy+oscKyIpZ0zyCmnbp1R3sBOGk/ee3uN1xcm/zuGMsyAlAbgqSz+PcvUy3OeDacAOSC0r
0EpR56uptY0PSMyUuvn9Z2LzfrXdugbndtPiqeSCUBw8a/39vzyeBYOeMFT9N5pYDWh9K82eC8/J
/0Rw1KInUaQcnbwSLPvWaaGL+Ka98kGnGYUqtkMEjxCXARii6xm/JA3NwYB8eFW3P7Oud43yOYpm
r9jD/ohuprQve054navj3psRSJJY0I0bu23nCVRDyLMXTR4boVVb2Uyo1TSdLNTMeMzzLEYGnZOO
5Bmx1t1YJA090UxVFoTrzhoZ+zkugWmRMPxMQ10e9Atb0yYamW3fc3yskKc1wsq3i7NYcNDdqglE
r1r8SVXXVIesscb55CgbLrdW5ZaxQ3Tf/9Dz2HmeebZSX6KLxLA2iyE+tErHsbw0M0u9kpq7x4sl
f3ZuLE+jrMY4GNGIo/lLNTV43bZup2WaA7OuJojbfmnO4JeT2JCfGgev5aZZ+c0b3A/5t7ReYDlE
dadQdE22NgTCQtq393Sk8lNRIG9XWJlH+LLcArjnafqtw5AIRWGwV7666aRYPKUR1j40d7i5oW5h
AUYvP5JWks+Gb2uNImUkRnW8yxDmm3cLOGDA0VnswFgGnH7dWiQtXeJ5G1pfH8bw1MowwomPPIoo
JDNzTX/xRP8Ug5xHJtfgS/FLl58TyjvgW1/y9l8uY5zlx6TR+nvIETjJtYjqdbdkqfW0DGbrEkjW
a7NvJpSsW4DBTL1x+yLtSjAsQnNoawgNneZyK2yA5J+RzptgCCJgBBu97yDFzsAFpv1kCOqJcUjQ
j9Y41oi+aObIOVnUeZckief4RSwI1UccC5g6owXNwx4iDmItUqewZSboo4ttjxkWqXepjMc0Guqf
I3FdP2MBtxsGN1Al3sbFronjbHKKH60nZ8ZtK6yJ+bQcOl0ik/MUxPqlQRrXLvLaTMhROFX0s42d
ayXpaaknofvtvMgntBbTA16J6pSjxNtW4PZ/To7ZPynuohk4okkqnLkoooIIZphJNFTeg4hgQtxu
M3NobiAQz66PRLUotmMxQz5BvIqStTMlol0wv99t7vETjIfyTsaEWh1YVxrE242RumSwzYO2X6IG
0bese0JzQgXyBEsNrdVAV2UDCxZc72f0l3kP78+FFyLSWZGOEhVFgKt/bHzCRFW666BBHHHY1eCM
hcQIAAXZCOpONg+Lq03GdqXA3hs4fX7KfrTAwlp2e5SToSGwYLgNQZ1NEUrxlDoBIgHaFF6qxchq
56Gk2J/t8LaETA7QdKkQG3v5gui0nLNpAYavOvyPZul+c80+u9Jm7AQXPT2gl9hU4hPj2/FnvJSo
YDU07FTuTZZpvGANtKaMYKQFWoaVPsRL31w51TK99OQzI/XX8vC5yocamXYRKzeIjIq1igrT/OyJ
trqbK7Dv8DgEJgez93CHzKpyPkV6akZBFo2Ns8s61Ok7l8n99yIS1ZMVpwA4Omeh59VoJqkgi2t1
oy/RkEKQxjp/aK1lMHalXnp3oVug6iwcRVLYiGGHH3dG3hsU2EAeQvZIvGWpCH/ai7QT7M6MFAko
zPTZF9ngXnamVbr992Iq0s4H0p3Al+aZ5c8wMnXJnbPLW72dAAnE9VQ3By/Dd4G2PFoEHgXIF+aC
tWbpXD/GOb5SM6Q2nOrekOUm08xaC+hASw5oODuxmuaec5GSnaJtFtFUt+ZcoUizWAuGgDwY9Wkh
2KVCEKtFVxP2KGdbedL+Cpgldw/anBU/lR1ZcmdH8fzQ1FpobwxoFaYfu406dAWYrY1lp2CwSzRQ
brMvWqu6hhnSOxw7CoUui6woY49ascI0BAQeH41FQRCE5H9FwRgqjMQ92PBHkPvGzyas3R8yx6YA
FTqKSXMytecJtDEPeaiplySarYWEQwzhp5GoOglIpRaAG1x8ObBRiATwDWtVJZsUN4I1QA7lFvIQ
DOpI9yhEUguux5bAjrbHAqDqYpXsLni0ppqIJSNjfrgZQjuccdB57AFqXor7uIq07w0Jml+8pes+
8e85xBs0+vciJIsOw3ZbUftY2NZ4Ud2CEKHWYCRrNDphTBima9T33HhIJU2YPNG61IQPIFmqQAzD
CPhfZ7rB5CaX9VYJYX2DKmGaGwnYnUJuNutNDcf/E331svChB1BpkTEm9AuZl/Ix0jv1ueOBb/xw
lultk5qs/iRLhQCD4KngACLLjsxixfdE8Mz4pYoGCU1FW7VN84hsPBB5lZ/kxOu1cXEORgFbYXoz
Ji00j2n2ShgvadzdGFjy84DmafY9t4ic36wDw5eao/1zOkThDzfVs3ZjJ5H77A49375RaAil4zBH
oW06pf0jiyXpae5UrbJmryvMbZZO9v3SZPafXdRHX/KOt25TtIQjbfS0rbud1AnkgFC9YLxSmqZb
G+V6VDQw4YfnvAjtZ8B/i9wRquM5BG5kKdiTi5SWOe5xhUSWImHQyxfMoA50ENGa1xOv2deycqzv
0hk7LALsusPGgewQBUluEeOUZ5gULyuXNBJ2dszoNy3k9+eBo0CBmSlNDrmxzIT84QWsj84Qw6SZ
avKQdk7Yp5zOU5eADKyUTrGNQzetMKGBRd8g7FuMS2lNi7N3iCbvLug/VNUTKKhQ+JOmtOFuigtv
8NepwGepWaGJb7qdOLZrS8cTWQhzajhzlEuIsmKQojMGv7KRf38rQgBcyUY3I7wHYHWkTnlm13MB
ND2tE3Oucf4jNKr4MfRoeUox92SnGqMDTABM8lEKkCEa5bjri4FDw4b4xEV9U6g7xQG8ujX5ZRmG
8jKrDBtFc5GbDkFYFDphDlwZFNPsaxQTJlEW9PUBaGdpmozQNvhiLN+mb6vdzAvJn5du72n4Kye9
XeIfZiMzLPeFSJybtIml/QOWI58HYSND1G1GAoELmR1kF8lS8ZTqvb+QImb6DNtKtVtTXaugrCc+
hVTuzIEmVcPs7Funr9VDC7NVZkFSu0n/uMz1Uj7AbScOFpWdHt73SY4YiIVhUfaOgsRsDpHXJiAn
JKGz5q2KLUbvG7rrDWGuC0cQ1B/xRAVOtJDDNorvib1uAuKHM4Alsmwf5qbrCY5rY5t8NsLTFmdr
6JFor7S4jIvLosbNe9U6tcNIqdLc1MFkSKiCewxFU+uf+lpIQp0BOo63VTWEINxbaABXeQPi3p+t
eXgEKMS4x0hDYW/SOafIcUdksUaYCOsJr+z80hoN2AKdySbELFWb2aGIrPG5NaqeYJjJGy5qe1bu
pk3DkSLFatgOCxzP9xoVNobQRF9swnzzxKDM68zoMrEJmmOhnHFdl1467nOm3wSBuKP5jKGyqoOm
7YVxqGNMZVu3XGR19GTsmSdjhEwInVA1JbhVbj7PV0gwT9U5LUdXMdOjW4hRhRuPszIGwJ4MKXmd
FOaByjVRnRIrj9Q28aropVxnAwAGCgyAZdE2d7pkznCY8T6YW+LDKPDJaetuJkaVo8l4YMgjwd7t
hHwQbVAcFkZBMVyHcW7hURPZ3WjI/ruZeNaPhdNv9KzpNV6RqoluScOgzReVQ9rBU2kbsmyHafxh
6lBabmgPsmBLM3Zq4AdeP/PRSR+Du8r2XfBo/2x4JLBsaJM6uLjVBxSrruRIoc8Z529XNtNxiJ3+
YRJW9yjZBhNCaOoCD/CgbIc8vXa8dYnrINhsQjdPsI4F0UzjzKvQr5PeYiRO6ga6F0X3OmSLLwv1
ko2yy+u0YEoqC6RMTLjXNouj5Rt2IChl1RRn9QbZA92EQZ+UOJoycb8D2qVHSkJuGCTVkkJqaUD3
0xq08C4pfEToJSzip3a/jrr/v3X2fyymUv++d7bpiX75of462Fj/wj+6Z5b+B7Jv/nNgPqNs/ddg
w/T+oAXGTNphIA11dh2G/LN7Zv5BY4K/odOoR1RMv/5f3TOYDjZdBM81UTWSrmt+CAeJ2O1Vf0Ii
2uQHQ6azau+YBzApedWfSJpesRFXj9ga9NsWzlTuaTS1NaWf2EcO8ZyJU4xbBBs0lqDxi+Xu87Lz
LXPa9V26teXnwfo8WUSAkjXX8Tb4JmEO2NOpqU3smHeE9VQzULEmP5GYSRf9EodPvyFNxHiyopNl
3hnan1lnH5ihbq2G4Qrqae2xNH5UgxF0y0VtHgrH8mX7jaQhTh55eqQFngWO0dR+SRbXjud7Exvd
1nETn4ovsGz3Z9gUKCQJYO/Jw0tdq0yCPkw0vwEmVkefwCN6W9Gi7xPQHXLI5YQ6us2dXO6UpQgO
saPPcVRsomE81YN2EjCDNIJ35AAWzkhxKhGpA8aB0bjOUZAmnw4JYtjDhD9oXb9vzDzAobaPyakl
X2wTDl8HZwCEM7bYkT0tiO3oByPIoIBFMIqrEtJZ0RxXhUATsSpmHib+xepP7cDP3/bbJCb+qIgC
oEZYVh0/1rTdyLGpxwanm/N27F7YyAI3f+mJHxJLuS8bYIk/2PM2nKrxxy7e3SCM686ogTVy3N63
IUaEtL9KCVRdJts+4FlMNpPuRjtPclcK+v5CbSCk/YzbcUM3H0wUxDc2uUdO9LsaGxptzoNLZ3DD
oJvzkunUV7oiv4pYzZOWX5riz3SSz0R/cuQkg4MGDO3RQHOuRlxo4IasrVV1xBoZ5rewX4o9IAvy
Ii3RXvcLJspCPvZIaxAY+8CFaP43q+WaFoXU7+vRDpwofDQKVBRKmttYPtlq2ZcwAvN+wGssHKyJ
crnxuiXeK/eiKA3FzT9mEYerLJIXk4C2g+/RurIGAatt3IlRBBPSpHipL0qjxwrc/6zDjCe6bE6T
Ta5OWR0tHtI6hnFI6Caw3T1Wap+Z9c6gt8GICgKmRgW+iZZ+Y4Fws7OEMw5nG7zxDhzfDGChttfo
POeCMDQPhpsxUG/NNfHL7sHpdTifow+ug4bvGEzNhM4Cup+bwHC77T2YBMg9NhNVguvOe61yt6ZQ
n0In2WLQhwRk3JoCNpX7GdULhusRXmrjBVp7hTbrqHNuZO86mFFdbxztpAbhk3OYaWpXtN/b8r51
trH+GMa0DMV0nMNsS5and2N4bXGkpQqVjxjaWQN8ZGz6xPOL/ut6yrWL2546Adc0zykZ3aNdfbLy
hhN2PB8mfbzrJ7k3lvKTqABpUfJYYCw3WtGDdNXvxvIpVNrJ4MifZDIQMSNH3Ns7fbpOyO12SQ+U
vEptMm2d8UVbnpT+bI6QqqqwvgXMCL4uBs/QjztTuyymYyfv0hZBdp4LHKb9LfG+G51cBbM7TWL8
TFTJcWlvS15+NTQdPMbikjiNgwJfuFrNh2ir1thCE4UpQS8YVb917JvxaA9+OP06lG6bmNc9wSLO
6alKtZsy/WLH5gsRWX6Gw7of7qdQPUP6wmW6FDxV3wqHkC8YbZVFPGw3bebpW8dpmsJkm8e8adJw
qa2g55kP+dgBRXD8Sjc2M+S0afkZai9FCp42k3Sp7gbb3HfJbZLQOxyuBzKzLhbLeJbElUu4CYMR
fTPmlCFo+1DajARqR99KLb3MJfi05ETVzCmHENtmjk+uGG8aXPUhj0vecdbSYgYRTpwcBiFoYaLS
Y3BNgmHIArgAHZtSpsDcmvS2W548909P6xE2cYdj4FyGvuW587aRPuxrBF788MIQtEjSELPs8OI0
C45x7XKZPusxLcO93pNYRxf2vu1AVkTNl0o4+zjSDqnBWa7MC/uIR5M1HgDQcukajQiw3l43UnXX
nVxqGiwq+9bK+IbUEqCSXn3DeP4rwYwMObpbbB8gzmz9S8te0xTp9LUZyUXCzWdcRmm7rVcbklVG
GzoGpCKX8ac8l7cm1VchJS0JAg0Zt6bXDaiWr16iY5cyjmHeXo2LHVScJXZVR8x3WVbDxijH5JSa
/Y6AI/1QC6PfAnxPmW+2dzUEP5/zBPdOd7JjPaLV9pN2kJcWqdBPdqPafUQ6ygMkVt9SbLKrvfHn
MHrmk6G36aGZ7HYz2PCCZGmmz00xE0OdVyekdGSJQR6F9yW2Q9uG+xZMAY5+YyfK4QBp93teGdGF
Bm7niNq5oiHrqRCndX/CHNU/MJfuyNFbmP/AWvFLhZtIrdlT8eDSgy5WNaWziTz12I6tLw02f8+B
WJR5vJHxVT0ZRGqFW0/qQFbAcxRovQgb59414q6l87Tn+HkDDWg8ZosZJLp4oi8cQmEzp2o3dRdR
VL0IHby9U+rFN6OunFNEXQvcwe4NDt9esoD/5f/TUkciBFMGeFF4Sof+YhbxYfKWp65pAnzD31VH
Hc0nEDsTkgBs0qPnVEejc8kOZsyycfo8oDDfoisGIii1Dt9BpnZR3Aek0zzpxQhi1XyqzGoL3gmU
YTEc47y+AQ6/Q4n31DjjPmbEH9ic3gPT0F2CdutDSbBWh6uNvb91lnV74XBAS8yWNaGMQtMOOWDs
OKHpoJTWHRbglsPSX3ST7b7krtdcZBWkDR225GMVau5unpHk1rK1tkavQV/xmO2zr3bK6vYCJcBt
p5GsTtqg+JQ5jO13KaGx0I6A3t0XogS3RBvwqy3qWLLKNo3hV7EAytjacsPJNvMrM7LAX8ws2pVy
RihNs+PbfWXeFKGgIFJJe1WMqbNvxCxu0YMwJuDI0T+SXi7io92JCt8ioVKb1krY/OfBUgcE0dje
x2KfLjUjBlLfnIwl1MVLDcwpKeiRlt7JIUWevi/DTIgNbZqf0pr3CJu65lzwVrefgPo5X4iApiXX
5t2lQE/Qs4S18muhg4sNMpduBuqfZmdDQyDTV4bbAeKtDnknNMiI9aoBKi/764nxVXYpeoFnLUm7
I2ui3IohmnfpAvdkFVywi4JDyuH+XHQWSYYmGHEfSUpxpXUcz1I4gd59Shy5pLx47It0PuJuqnYz
VONNGdvWpTWF42cN9OIXwU9/bYNjDsYktAIP2PrWbVv7tlxm98prp/KWHyU8qmS6Ix1qBcvQkSuS
5jGFsHVMvMylWwEBAcDovHzvR1PtyTA8ViGNDw+s9s0arL0jYrJlmm2F1IP6RVpZ2nVvlMU3GrXF
I+D08lKOnc2rx9Sin12uVyzQisq2YsbBudwSCRgoR42XBIXuAboi/ra2KVjJXWKRm2dJtz4B2m4C
TaYPUdY8zYYW7j2YCLyS4GmTZtvKxPhKR7880ctYkU9EeqO/Lv/M6Vs/KkE4b1mm46HVqZQzI26D
sJ/DnTm79oNTeDGA79KEGRkafl2PGnqanNpqdrV456UrIdiQEKP68IpOSn9RWkNCTqYNb5WIlKJ7
GhGJKPd2qdsvcXRfl6Qh6+GQEslcHcdErbxWwzmEkkzIKIw/oUJKt2Ic7pW7cq9pcPCOevGlmMS9
1jEkgFp9pYUjByCiLX0IFxvyUtXPeuTQUKgZfDnDLrOePjfl5KPf+lUbHji0h8eKBg1R2hTsmfoe
KXJhq8R+NnrnMRlWljFn7SGRN6EY2xPxrJdJ+pLxXQZzpu7CpO1u9ISdOExUETRKI/eBjp7UAHnI
idI2iZKLLq7JRUXaEw3eXYYti2XwYvbIns3oLCHPeIKOdNNZbXvq2p7TQZ1tIuCqe6+mhwWGtVzP
LSaHFNjqJ8NccUCz5tvkM14NIMaCwis4MHlimoLY4UEB8+u2TvaZxZSiuDEW/Og5mdYg13eMVh4j
NTVXOfKII2RtL7lxvLYKFp7bn2SA1wEE2fDYaJqzBdLrXk3hXKgdhvYarqspGciG3rjjpW+v0qyH
0qwUYqgByNImByrHm5F7gZqITo4ap2/RM6wNjDrKWU/jYfBrD30SlKiFc5Sbm5fz0pUm96Rtfgzj
pI1+VpV6kPN8ByPIrW84a7jbVnyqoJW0l92Q0aaCu9QzrGkOldaETOBSXaoLu502YjlIRhs0j5b/
Yu9MlmM30iz9Kmm1LsgAx1xmvegAYg5GcObl3cA4YoZjckxP319IaVWSsjLVta+dUkqSMQBw9/Of
85183WgQtWfjC7bttlXAAvNE9itU01cOxRklANMb3hogHwxf9/+rqPTztXjHxpXxzxWVgFqN9q34
2/+FOPDxVv3t/qtW79w5v5dYrr/h7wYlF0XEIelBNY5Ddvi/JBYDrcQgb0KWwcCDRJLxPyUWvEvI
K1eFXADYt2g5+E+FRfwiMC1d8ZeWfQ2Xec7/xJ6EEfWPCgtmHnL/uM9xf+iUC2Ei/aPCojqcQwQ0
t6ksSTev+pE1XdvBfO9oUnCsndXqPx2mbVu4BOqntehdyNG2v9SeL18Md5gubQykCk3GrTZxZPjP
uZW+m41sQa3VQxc6SIxb6gWMsIxG6OBpq9tfLjnfA0BnJ/z1N05NyrFbFe9zLoxw7rB9rloX4ltC
ZzuoJKuq9yDMpucYws+psc383hpbLAocIrIVjkV+OgMovTRtdpH14jxFCSWxTPTcoFfdp0WSqF11
SKh71gV3V0PBuRmdxKRSgJ/V56nC51hUNwWbnC4C7pukZX5JbfWZ4a09c8dPoVOYYp/Vur4zi+6z
jCPtJa3K/iL70g0yKDUv2qTcc2LH1VYl2rAnZeaSh6i7b4xQ73DTk/31J7WR36jnpv2oqfGzaYmX
DEQuTjRZzM/jyB9nPmZ/N1rq7ugAcXcwCN7dmA9wcc380nrLYga/vg3OQc6uTvicfn2VTCTyiy4a
9zzO9SeniHc3X7oQw4QRpt31QTXZzq6ixSmMtd7+tjJdvvjKagHYYCi9ANfRd3aXQFn2o2QvGIGE
jKsxxrr2N9/qRDNwy5vQNQ3GXtcYDFxnK39irMgHUCb6xukRKdKStx1fXzhD6PwyR220Vs2cX0bL
qcAWcsWdFxpQYSHx8m231iESdHoeXKO2GEOx1e4GsOvrinQdg5iG3R/Kk/gsFb8TUYbaVAcku02P
LF9eAy11hdU0314/XLwjzm6ZSs1k7xjZ35lbvDdVwV80x8+yzd5bGDnY62y5v36sldm7O4Z8+aVi
aBeaTfm+xADxac+mJriOnW80DMp8rTjdm5IvpJgTd0cy95NNlXNmfDKfZ621fgpY1Eyrh3Pe2+Nt
NVOYPXQ0r/J/fdYj/ZaqZBIqQyPF3vVSON9qbIqHtuldtLPRvWhpkx/hDqZblyNVgjBoeM96brRh
HrX6xe5nb01ExzvhAcYE7PhyWPkmxD3DdbRQ47Y9N0zw13o9RUdWXPMG/hUin1DtKz0yY+DQmrX3
zTwJiNgQRXV7jsla58afS9naaJgVirwtZITC45mfpi5RCXo6g8WqxQHAvqO1Q1Mu3U0fA9+C3dV/
ZSPjXXfwOVbh3FoCC3oY4wavu4xc8J5k3DSTualXJeOsLUgt544mcfOlVt54n4G5WLexoCG6oI/7
jeHefAT22B49QNS7mFKWe2w82ZmrXr1gVMFIMlnUDOQK4qlsdFI+TEAO7jLqG3BmVyeZRPCMDadZ
02UhzkhW0b0v3YRLq/dvlZ7mIf3yHB70RtzkbFDOcT21BMmuwcl86Ol61qnb4LGRwOUaJB3jPkw0
XR/xUVWxt01xNKDwZM65d5QJ5Y6NtS6jZEN1ih4sthvTwV0WLLze5NyMKjffAfKlm3kq7L0q5Ydy
nQ5F2aWYdx4m+1AAflv7lX/G1KWFFVwuQvrdI5RYHOr4Htu1qUeokBg+eIVVuzEHbgn0eTsUqbCo
7EnQgagHOgya9SzBTt4mABmB/sn0iakjBT6VZr13XY3KkAuoiJqjJwb7mD4/lJ0AXgfjxNwbtfHU
6U764heu/aJq52AutoWvb0weMbFLuGO9xwWnNeECn3iXLiMEw7FK+oNVddEz/omE0X0/76Je9rcK
AuOuLdG18e7ZC44fXCgjx7BjDyz2xiEhdM8ADbMopKImaNFY6JoBZbrqMm3Z1AqvYwCxtPjE+v/V
Xg0oiTbtzMRww9lZ0gdkc3+ntBrIn8e937P8ZBFyXA/3LGkdah4qwam6wgzSTldtInHXndLbM5+/
WrERZBJQlNkF5gUWHVxjTzBZF2R/wz4k7F5vIVRqQULZQdgCFnidTDc9JksEbatT/rq7VgrZE1L1
lItinYhmXKlrKbUuBTPz2I3fFiV4Ty07Z1idfagv2o8cB4gJiFdq3CqTxBDmLeXNwmE8FK0Qe1VN
DltsIOUtTj80cWOgFqKcIM2qZIeFiNs76gesvOqmzbxpJXver6fZx2KarNAHxr7Xndnf1VEx9dyi
tjxC4jfXrZrbG3jIfB0Gjlp9VQ+mcUwwWx5nkVAQQ5KDC8qwm/tEr5MdmxKG6fo048yKxj32Euel
HfRyrY3e+KHNscceAEFsqFLAtnX5hIV/eUYw8o6A2vXrLWGe3YTcBXrzLA69UTUc62OHI4IzavYd
kFYInFQ37FG4q1M0y2Vn2i6cexEVIRmWKlRa5K7FYhTnCOMnmkrXbMGkOmvN93i26pIbwmNBbgf3
0C3wGJ0h8i9wW/r11MSMSK4rFetdhuZrZXdaHN+zl5/PsT36x7Rf8k91nRnJyMZMI6tHPKY8nw2K
eWpTlF/x9YAN6mBadXPNVZxZctMi+t+WRfdQxnPqk9eIXPj90fjFTLv0V940ZxTJcMrZ+VEpjl7l
aHd66VANw5XqHhz+4Cruhubis5v/xPboHjsmN8/CmV61ubMIVF5prZFFqsO30/Ku6Bx5mqFzIokg
hzfRMnI5pvLe1HHcBK2BnojRI7r0srnDW2hsRZ3ckOFp7lJXol9FSDOrthc7m9+/ISB3q7SpClMc
LQ8VRrAwz7Rxy4D6UkN4ymd3utU4piL/DsXqavIIEh93FwuutZjlDffqHMCDM1edZx1Gt+2Csq7L
i9s2t6Q1lyAtxWOC+8cpl3d2sHMYTSk1DL79k05vLtPeM9d1q2vctFg2jWL2g5pjnJm6xqYFsrSW
9qQfylm7ZjpcLQD02D1HY+IeedLA2Rkx5kqFFl3V+fDOiFz+xPfBWINDcXtZbGPaY9yzLtSVmYFr
Tf59Wvv+tpOov76fLN8tlWbtqA8Pht1Fl0ak2tmuqNeyGhFvhticw7JhnXNGz8Qi6sm1nWKOE1Jr
1wNkTCYf5rzJZsfc1KOyPszUq5h5u3Ozns2JSpy+e3JY3G7KbGqueDRD21tCoYxVEjQfd42wYaA6
cCznSn+CMeN8zMBlKDvKCZi4HY0KvgMOOVLdVs19g4bgThtTckb3Bs8NdHXtv8mnQ+LbPeoUt/TB
tMGoLyPYTlU46w7oziHLqnIrZXlTWD6mecaWW3/oqrOm8Zzw0s55MvvyhRoxelM4bq9719L2NAzV
OJkngZ46l2sPjxokMBNS64Dc4Gjj3dTIbGP6NM+xOEy0Brl5qF1lelz5y05W2rxZEMOCYe7pgKpa
brRkSI9DYzLVtEa18xA6t/WcpVuNuqPPmaTvNuuYFulU/9Bxhn0sTtVyJLKz3E5sCqq8aT5iBwac
nrY/O/9aIGfN2d3CfmVr+pN1kjPDpG7wzrWdXDCrUGY0QbHOukrHvGpcSENgNmKcFEikpi0LAwMb
gmyEG3yt+/CnxXotWN0+omT291VNyf1K6ouxp77SMzZ6NNc8x3PNvOlzrIHQgWxPhOagxiOmoHbv
WoV5yx2LiLtY9g3GctzZEKTTHzoFmiesUfIcDRFE6Xm2p8eh15q3tEYaqIVMdj4t47eqoy/PkEN2
UxbjcvQoxIxWbZ2i3+NQl8xqjObettrqjum39mqYSYvMbzvRdjQ7fIesKi6lbKKCPhs32r3iFmUa
Kc3o3ZZ5tGNP2D3TW4XTzemWea+lnfVEfa19SX2n30SZ3Wxth5LEVZ8VDH6y2vNuR7/Wd66mFyOr
Ud/Q5OMzdTHJsmUryKlqv5Ru/U5ey/1koVj2djoMIuxxcAL4FMuWuqGcsbentkUzus/jlI1r/F2M
b/RBGjeMEsp9hXJ+m2LwK1di6PCJpPikqQSwb6gGRcJ2u4VRUJMkHHdcuhHxZ4YTR6V77Vqf3rOx
chjOrJK6fCM+G0Ni7oajNyGfu0nfBpPjj0hSjBLA/P+YOib/o2Y8lcSJgsodIKV36TouMfrFEkuX
Yp0+UZ1jrSeN00kJAXTduN5bX2fLGieV2mGXHk4WWObTEPdvuSoNvmlKXCaoYKtYY7MecdF+Dr2V
B3E53LtLvfVyvJ+8ViIxbhuIMT/EyhmRg0ss90mjbfxS4TcebIyxXXpjiWV8z/HEnItktr4Nvzbu
Rrr8Tj7BllBVLpuyOY3Xk6mXO7Y/d241/5yhya3MdMBcy/0aLpkiuTZGzsE17PhQNb0Gn5Fm2lQ1
pwlr/0rnUBq2MVZfqNPLuW5VvpvdwXgmuN2uHBduNkz/Cmdofxry+ZNnJ1Mikki70sXjBER6rfvE
BzT/OWrLx3yaH8reLje9Ayw5S+fHSl6t1ti4qmF8mkrXCxB7rVeyEctRltjvTIAAT9oENkK45vOi
hteoXKpbZbsJ50AjCgS3wk1dZ6zmlJDUtlznpfE+lUD8J0WTg/IYXOFFAvxeZgW68NI+6ZosTxnv
bS/Z7zLlyh6QGPZuonLM62MOlzcLBmJWFxQEM5zS9n1O9ffqupdKNfOxnVgl/SgPGREkh6wEYU0y
6aeWk5bqDfshGrVvSFpQ+OVF6tMrnWTDhgrC29KmoK9yu/kE2107OL0XbRaHsbWJdr1ECW8fnOlK
GdqLMTBiZQd4GpWXgYbJsV/pDdwvsM03TCqGdYMF+0AE4TqJq+2DlnsIFrRjbb04O7MtpY1Kt7DZ
Z1MEo0Sf17hB6v0iKGZKenUysSJ/kFWdCSYqnaY1OJahzyIXAnecHrXY9Y7eMvg/Ca514eDZ8Xoo
4kOjC077vvmhs3IdKLRcgTDZeIXEgFHaF7+pBrrcbNpAfPU9967aj7PJQFLLmEnLRWwiqoX4aoAC
Of5PaQ0PS2thZvPFTcr0lxTnNwCrDxNscdXkB/LMzCPZU6Q9ZSS4346pZN1EyTlTObwtkIE0Mztm
DWhPSyfait1HbtJ+fq4K7aj52VOX1uONhWR6X0eZFxhCfuMQ36hWfNraso99Lwlzg5Ncb+dnpeox
TFRNoVqXDOveMF4a3X9J2d8GvWh2Q2UfKZFi2K98piZedyDmT9afsW46as7DwCKZc0FgztFec2zF
q9bPrW08jT/wx8GOpgBp4FgYO9fOwSzmaK3kNrLcC6BUBvJEg+j0KxUTuKIMPTFORFVSgh/d8s0F
Du8Zwh9rgL6Nyum5ju3yDiSB2mp+dfAwQCEAFE+6EW/LQsvWKNshy/az1vunWhXTQejqC32OgWs9
v9K21WkrLHyPQoteSlNb7upMf4XczONq7H4YWnMnbeOrtMqXxvffxzn+zizvNKBixyYzedP/jgtj
79Xsu0UhBMWWkNMnK7kH6P6WyGY8jsvC1VabauMU3T7unfZHrWmY02mXvvSokOwV9ehEh2bGXN9k
JBYnORvNrqB5yxErrW38HStefZ2gzVurgFZkUtzVqCEobG07YBOfOnPbSutQVjGnOs3ZNfHySdHG
dC2d7lZEpY5Z1LzyYT70VbKTpTxT0IE5phg2yixYVqmMhOcRMLhDESAsuCuWpNkUlXQulbp2x7rx
KhuNB58eNnSmYaOndF0uul5vQG5T41vfU0rwGjtmgObJsalwb/si2kq/ZHDn7NtUrhxOFSt/JB7j
O3hwkvS5WLDnzhglShW/OZnJIqKb7PrGLWJT9OT+2otr2xvssOVqGNx6xz7+DgT4DffDlt9y7ywQ
0tO2I9Fmn60o2/cTjRCzV7xkTOoHMs1pJI8gajSKGFUos+WphlmywnqvUZWGmtFZyV3JurVK8/lZ
TMlBL6KLpZIgik2dmEQyUNPr75MY14OXqp3j1PGjWfnXqb56dSgO4zzcwL0oSRBII9nVPMq2k4ij
Vd25XL0J8YqtrGFjLEvhvrWt4Aye47fpXSCmgZaL+r6rhydEQmPbFZpxSOJCB1WnW1sLd0m29tJ8
FBeqvsjCK4lPbkiVi6RwbTxCJ+aJXCcIkAtlwOa6H6q6CGbcSS+LH7d7yhOX9L6dyurBbZPkI+pK
4xVlzNoVlRIUbWqlurCY2OrgKQb+9MAwYZriNF7W0M20Et3RIiNHEh17S1Lw+MZ/qIaNMBSeK7qA
O/KMSRT6U8b/ZvKkH8icjdu2ckpgtH29qRhe0e4rkPLK1BuPbmea1X62vaigJyOTtER2g5i2VWLE
I0qan1aMomkOCjVQXsWa4LzVnkcBn+YMd6075iUXzDobVQplvhJmcqn1GmG1tqkIxoeMEVz1JR3S
dE9Emw4Xcl+1ZkmhyZRHYTtDfmTTJ/Ez5Rj375AEF/1mhsyD5kqmPgniri3gaM3DYw3cE+XOF+15
SGhZIcJexdO2ppi63RC/t2tkPO6YN0uxYzky9m11psX9otZtrjfOttcm/Qwnzp63+NKqbWLp7cEm
6vMA0wElFCh/ZO9UrmbarUaLIYHOMaE0eQMPpjXG/tGMyXZ1qVcnXxzhHLWtdHPsqfR0SgN+fK+3
2QrmQNI+1V4bO8day98jwX/8WS2+P5zw/DnewUqWvAMsMCKjhx7NFfppapzhVbjYh04zbbSfXL2t
v0a+AG6/dqMiYc8+wfa6s/yO5ih9KaxxZdcWSmzejhFWcgelfSa6dNuUTsePJpYRghaFlgBnpoOO
mtMfMiUzhrdKSv1DVDk62jLZRrdTRYLvkOG6icEK48JZ17vZ38Yp3xQeUsdtt1gazP5TOWVTa3cl
B9ujsNtqCuJU954NEw0IaO6COc9c3H5bLMNnlVXxbdQhMIR1yX9PYTXLdU/e6tYaPURF8x1IOxMO
6fm+2s653tnBaKTWjsOKycfe1ElIQ5GBVw6xn6vvnXorw1xI/OIyjzibBrSPVzObUd+oXpkTtPAt
9Dqebmi3dGueN9b3XA7KD5Dbk+aU9z3TSz5M/mhkzGN79qc6+1oqOvuIznZ1cSlsqrFGD2jGMZvT
xVrTzGcn96JwxaUmlUraUNMNI2TSIod1VxV2t2FOXrDga4NrLRs85tNzxDYwegCAO1DY5MX3WeoJ
N1kh/zpUp47UHAVibj+xDtdIyoQOJvYg5dKeFdlYYyW6rv2hlzHLN0f34nnhsU07abdoLyWtj+5L
5VhZuQEIQnXZjP3+WEgBPGMua64C4fdk62o383+Mdi6ooW7MJ0WZXXilJ9VvtMRXy9ka4DJuJ+J2
Bw9f1DVuEOnGM1XAGo6qvNKbPYQ7ejjHImuxJ6XW0yJt1nxDLfbarVX2Q7c7+22wh/6sjYNmYsaJ
BRXLdt5YKxHFhYsPkAqGa47szotjCGvgZSI05FhTYudyRcEhEV6IjQEx0fPQbcProWTjF/2ua7Tj
ojsRHTT6QmWz4sGOhsp4OIllup2L0rvldI7xz567kpTcSEBxlnPN7WXVU/EydtGUb60x18vA75Is
W4/oN4XasnerUHRl32A9aFpOW1RdNhiaJ9HhGKKGnkLIIUtN3Fsdvm1JgwjTddq0bhJeRn+tla6i
E5s9rw8oone+IpJN6A+jZCUqOLxC/3b94p2eHjinUojmM7FBLdC2Qz9U4Iik/oazYVy0Rrcg0PHH
7v3ZYZE33YVasLrKmnsdXVU/Erea8yPyb+2wVa3TyxXWYq3VqPnDoeJV+6s+avKg0nsEgyzCWkP9
enJnDcIl1M7lvjKlG3tBGZtase5Ekmk4lVtfD+i2xMOlx2Mx7svGLymVqvIFlltVa76/6Sa0mu9J
+hkeah4Urj1SKqh7gR9Fc6hFRnnt8ek3PhG2C1u6bkupanUypMo2PdPEgN3Ndknq/pHnvsmH1mdf
nd1U177RSLGczWs64x2iv0XxbDTFzcLGpzVzzr2pM+9BGV59Mp4fkF8eAuJL1R2fJmaNbv6hydnD
9TvfuXLQgc2iAUS1IDGqzA8EVUpiZf/CUludaFvBbp9Ym8zRfhIKw/3SG3c9O7DPVvGwqJkO9r5V
bo2xY/KSyRCmwHic2MWFw+hEp9oxH8oWKEVqeXsQbCLMbZGv7KpiYyUFvm1IvgvbNsKCk3SvQUrc
Hk0fzJwF2tyEk0alVpw3mwVa7OvsVmArDN0PFovNA9+f+bjYYwyg1nsEBNAwbEMSkCQyU43HGALb
2p0oF9XjynvxWKuroDGIOWcA/YNMYYiTs1h3bT4vXKg8EauUbWwrl+qcpm36UqPhsB+uu+JUN1Xz
aA92eZPM8VPZWOnGnetnskr5GIHZGTU3sCjrmnHazHZ59iKXdD0HKmqfdRxgBEBbUa/yjogXliQc
X9KYbmvs0QeM3M1tjxKw7XubVq1owndLAaLCz0ife41Rx1rqHUfePQ1hct1YGdwPXbtld98Go5RU
MZftXRSZPAdylwgx5VYySBX5/6L17+lOpTgY10xvLoDtZ/ekE1sPtMS4KJ0DqV859Sa3ljioFsF5
wcrfFxrnN9U0VQ80vNO2Vk8iGKNZbNErSWhpy1FNer6tMlwAMOhIHzk91JGmiym8SuixX6W+0MN4
prNOxXF22/ic2ZK2p7i4zu7KwjnGDWz6WMx7KlXWGsebvUyzF8sqw7Fv4h3nGLbkEbuWg595HFEM
JZ8Re8c3kUpOAT0eZ+GlL1qd5MfKzH8Cj0zup0K8TrJqg76ztbU/SnS/Ue+2ThuvTX/Y1M0iMHSR
iRaS1UmP7ltjBPvZXF1h1rBs68xUX74bfRp5wpa6KueQ8jcLiH79nKOA78fO9s7YKjhFLElxKqA2
XxXTOoTcvC80c9oQkhGhsNn7ULGyfPJkSjnJMh5yGmngdqYat+jcsGUvQigdZpWTTLQtFc9qSuTJ
0oot6Om32aKCqaNFWhnM0WxrfIL333Dax8a5EORfdZBhL1aKYt5b85s3EXw0Kye7FvB8maJkj0qk
mwrBBeXdS+SGr9VZRx2TsYFGX3xs2ZtbEgpDT0a0E4oRoz2TpPVoaYRo+oDu9VloJPXHafI4JWWg
reblJhGVt8eX+aRZ7sSCjw+CISI7dyKGrzIX7pa08KaZ7R2asRbIyfqZDR1hh1Z7GPJv2BOntvI/
PMWsjcLuhekfm+syrtpHzL8Mq4x05xva2mjxTOo9x3btMJfOrfD51jvhFftZmuI8J9FdKYb3LHug
Lu+Sa2yOGt8KOUUcdT07W2Y/EDTWbkVcY3TtZw4cZvnuQjwhnM+gPJteeiBXZ7uxS5IP5CbiyX0X
A65j192ZutplUj4N0twNmdqURW98RHr/I06T/qkgd4y+xWY19z9sZ5jWJQ+htndeWzL6UMbiDRR8
tUoiSr1kfZgL0w54Gic7GEWXuHaKC7WlKWONeTn0YtQYi0yXOGFGGA3wO5Q/rjvXQHsx+oAcLZ01
emaVK92aTlOrU803+BtnZN7XuSK+OkbtG+z2t6WaxotwaGu2iycv9vYEudMr22S/uEoEyhp20TS8
+xnBQb9MKELTsrNdZBy13fZJ9smhb/Mwyus3k11g3mh4Prvqo7PpvCIaviogg6NcVckl6kVQiOw5
dputGdf4Ifo7X5fHzqgueNx2i4dbLit2Job4TNbOscMuDrwjg75iQFYMMwPIWpUerBLLgawYZGD7
Cd3WEIxN5FPi9VuzsqK7thjLtZy1zdJZh17lX9kgzrlsjj7JoVXuVVmYaQ6o24rLv0iuiDWdCV82
vRsTDQbUT9bryJT2TzNnBkp9dRpETGdIR3lFkHFiC5pSOFflUWxabaLtN3bHe1/F5n4YSdv4Ro9x
w2jwRjYDQKOwEdbJUb1x7iwWMJGIJQpimzIxagZoFEnScGxnet1c3DAL0hQdw/IoSu44P7GY6ukz
xXReWu3hHF84WWqXscjpM2TU5WPT51iDQlez1iyDfV/Y+TNRUwnuvip3OE/xTVus6aQ4aWS9s5bm
1MKAYjjMa2xFoQVGknHIq6Lt5CVqjxI7XKzWtALTdbVbpehq66oRjZLQuKvs5lSVnncqsqYLkny8
S61ouyDqc6jI21DPlbVV0eAdVFfl27GbcCO359Swn1njjmRE3RVFyYAMCsAsrTScXS57LoLRKu8g
9Ji3zUCOjY9/CLw8OmUxjfBA2zilILIOzTaP6m3StFcCzbvor6pJ1hsBLXCBRRwjTO1237vjSevb
E1aMG30x97BdnlmSmLxPoVnKp5rCnHBSgA4cyYZ7NUeR92l5DRl15fRCrRn62V+jZaY3mV9lJ3RW
/yZG2D0kaWNm1/BCHYLjsj4dkw1d2pTfOVTogBlaGZZVyhbe7bw7g21yMM6cuXEY+SGrj3eGPuOc
Sk+Wwf+aLP9ussTT+C9Mlm/119+ev9rPrz/YKvmZ32yVmhC/OKRD6RV3TcOBw4B78jfwmybsX8jL
+BYrtwC0fTVP/j26ari/4MLkxCBsC9LyH3rFrV/QUWmruZaLCxcy5P/EV/knrha9FLbnAgXgBVxF
ENqk/uiqjEuwBbbVxeQVMTnkVsk/Rox2X+0aRXPIF/NnPc8xD87WFOv6us1N/dw0N7iMyjdpEIGK
FD4mTZPU4mbXQ1FZ6MXFqXtwi54UR+XpJVGTdPRwDCwC8wrzP+9HxHp5yVTOESOfZfmCf0OdNKxd
E83JrBXCMHet4WsvqpE8SzI5bxNl2e+MFLQ3q5xNBD5jXFu4c+APMekvKBLeU3I2hrkj0qfffan/
DVRNXD+H/8Lj8Tl5FE95wgRcCiLVurpjf88fowa1aPLK/EapE/gIgVt0RTONW1u1UWDFBejIyigx
v9hVgwjmqA97pjp6VVgu5g1MHdODlmaGDntEDM+6A+Fq1Q5Ty/gquZGFrIs1xzTCFuRv0C4NpdJ1
xfb2NzDjx/Qf8Zf8/30fLklqaiyEr/vOnzDL5tDFHOvkN0JLcl9G0VdiEtoo6oyHuKMRD43lZ1tP
Fo/j2NzSQeHc+yDzgn5Gqp/dmmRwHxvvEZkLAlM9pSmlfhqyUey9OGmPeTVYt2aVZGyQZfoXLOXr
a/vTdwD+DVnO47YBXPknynFr6rRC+fF3VUYlrb6edUJi4NjVD+Jk5IQB//V3/qfKset3ToeRgeGY
G4OAuAGY8fff+TIWjF2E+4VG/0PL7aekWIy1XWf9Dn5ocYzGUWcjilMYFjnX/lT+hgL4p1+W+Y8X
nY8rUheOR50d2fI/fVll1k0o0PKLYhzyixhJS9xbkDg+ZVSJ76WIGj2IumGPK8BO182gz++lhdQQ
LKk9v41GwwSJ6Chr5SQuduXqMJupCf45oF6sQRq4cG6YsApYExruB08QzKXFUsNgk21a5FAn6DAN
6xwAE/eV8Bh9ntnAeIudJ/mUpG8etQhICnWxXv0XtP5fK6r+8G2DY4GWadtQg+lW0P/05i08o3GS
9B/Qi4ZmJYUzH2bMrj/aiSQYs49UbqSZ6t+JPglQstGErlIbUXcuMIQ8JLgpEhS2jg8uH+WMvZnp
KTHNWr04sIPOiWMty2ayvTvH6+znKZnGM/+qZWCAlsXDSOKxSNobOFLp4+R5d7Qbur8lE/7pF/wP
FzRnKa5jl1tRGI7158InbhEZD639XjdMy+0ISEgBT4zdnAFSJ4ML/68vaPO/+3v8SSgkrCpc1H+y
0Dcw1oQ5N++KAesPSHn2es6xmlZFX2a4Pn3xZkIM2g2clCnqgF1DPeu9YKLBqRWaERtuSLEgyjQ2
vZy/d2yc85gzoaVtSZq4HPS9xgyoz+wVDD9O68ssurvUa4ZHmpxQoZqU2H3KvPYyF/oaWCKpU4C/
ZssAh815q5kDMwusT/hn1DcPAePCScUMtKz1nb/4NK5Piz9eXwZlZQ6dVnBPIUWz+v7+7i6tlJRO
uXyMPj6yPGZuMPORrSamKcd6RRqPReYv/iRL/T/+SUdnRfc8WmN+jTh8vN1ztOr+z78Z/56kqdvb
9fShF6239/N+CRGZ49DO2Z3966/a+CMvk2cXN801tMHji5gYBY1/fHes2ChDbfcx+8MPp5UNqlHf
Fa9GFQXZ4kOAcuJx2eUkLfhCgDr9hP6X38wWB7S/eClwaP/8rn+94mBs6LwgzIJ/fCm5z6kzEf67
ZDb1imhFG67yrfZWZC3u4mnAIRck/4+981iuG8m67qv88c1RAWQCCWB6Lb2TIzVBkDIwCZvwePp/
garuFim1GDXvqFmJJC5wE2nO2XvticN5Fo1IXCw3tu6Tsh3vRYa1tKRlcm0VmULvbIXROyv2Hrtp
mM0+HFKmni6pv5ROaUDsLWVTUiwIV38XxCCuVfhvZVO4v75DcESejS0EM5GHsM7ZP32HdroETW6p
x1yL1eucT+qr3dKrMLzk1+jJABiVxFRA3VK0MWrem2+QnElFTl2XCmYsAO1ANgxXZtZ4tSCY2zvp
Cu7zuItHOLLz91nRVqCRvEzsJBbxDhFwe6Xj2b1fJjl8xAsuri0L/Oomc050RKI4KDJQGv4cDMgA
qiCDO9nhw8AfVpUnYu7nB/xhxtm7M835uvMQ3qNvcUFoXji5XxQcb7Mp3ICrIGoidpChOhQPlk2P
A4DWdIWB9M/j8zk18uXbJx2Ob7bLU3B9RsbLxyiHDgt0LB6NSOwHtzcKOVyCsQ/ve4Hdty1n4++c
cCrOVaUmlDFUXspOm8vZSgj+tgefSnXeEn1sWMbRjgzRZcyy+L2Ta6/MEDC9DSf4aRura6vb50//
P0bP//m8vP/9sLPvkrSq08efjzrrb/w46rj+X+B0JLhqR0ppU8n710lHir8wETukRigqccR4MDH+
66TDcQbBBLnRq5GM3D8Gwt/pA/IvXjB46SHro7umXf8jwDXnmhfzEIa2QK7ONo5NjgtM+/XsS1bs
ZHdqWkvzTuWfDYXxbkTtNYRYJCJGbpvB29sEq+oCl5gNF9FHwbpYD60xpqX44gpzD6/ENdsyVPhB
cJT0wpynfp49yDEckrNkktRS/MkgiVwneb13kloFp12T5emZ6SsK8wkAMffIXip68L06ummrhbEq
tEaBZXlzM2yoZxdfMbbpz7rQDqVKDXDgmOXO8g5sWTPvcKbRTtClrgc06LVPC2oa01twxN0NTbgE
VKqKveloeyaGVVtojw0TQni91gDMOd3CGOntvPg51THbeMem9FZfRZqN9WmTWSlKc7LoG26/jCHo
V10Y7QbXxPFhKuxYn4HACu1rmjOWORae38QHHZWQTpZYoKmgd7yyyJBGFsxR40T2xHVWdQizN2Ng
p2wqowY0HlhElY2bsesQkNRqsZN6V/rgMvYeVFc1bnx8VdimpsyrN/3c63h552dV3L4fNGvscppW
BKIFdIjTaerPy8nq7P52QJucR1tgQ0kWXvWjrdrxDh1FCZC/aMGRFacThpaWIm7au0Wz3C2K3NB+
O3BTdc5WtzTo6zHhgwhve7LTKdOZ0D/oqoAfpJwKIRzCaFmf115WdOcA0vVnpEoVR6jJT5rgZpwT
AtcXGu+gPEKDhB1SIGYoaH7UitEtO+UdMnmpL2Xbtfro5wOcGknT1dqpMoA+6TQ9MpXAhCtfNKYJ
u5Op8MXp0gVVp7aRHtFbVGMTpifzmgXRPsdC9M8REdlzXITJPDTTbmyIkVBE2DOq4sGWZ2JO7Oqy
eo6dmNK0fB+WRetsJur1N/GA+G3nSMbcZlnjK1or99tjFy/BTdK2k7OjSAYWV62BAXxDGb7DNUUg
7AMSBbRMp3vfz0aAryjk1nH7nECgntMIhpZVa5uCocAGScABpqFsoDUzeR26PhgLKK+nPKBWOXpm
Ep+F1QGdpORI9x3Pek/tlG0+Ni18yqsGKoprc+uExr8LaainJ9NgIxdtFvijkEqNbZwPBCvYxVEk
6egdUsY67aLcqvrTOMejdxqFOURH5NeLl116s9+OtH9QD6h71GtVSYitSjKxzzqMD/eDZr1hzwri
AlpMl7ufO9x30HrAaQOQSrvQ8tMtRrUqul6mYZSXHi//cJU0uC+3Vdl51RcnQxK2beJE3djNUIbw
Axb8hoN2iVZVhblykJBfWY0zultncILbZml6lGCguK2NW7XWORaHBYd0Jenbprqv3W0zpQ4h8Z62
b0Xs5c7etpLZ23Ekm9gO2LqI9/4SBe/6YG1tYKOhoeCk47Kfcy+5jSepj1y1wDsSLg6qHXhBSPOa
AtckguUhOdjEeZ8SxVa5iKZWtwuqn6o/kiVYP3lxNocAEYnW4zgWZsghMitExuTQ0isZI7dqjvy7
JEsTtWc2TdVmcNrEbN1KDx7eIw8FM4JUbER+FcQfsmqYH1tb0owIsPhixiLXaqIFFPEugM3Iv8Vp
SJ1FW3PwNC1O4+4QpGL67ZBn7BonolubwN/ejtLRZ1Fkwx9osM3LzTB7wFe6GQEj5+UkEPsqjDg0
5noYKUepxD6DMF0zcGxZfAeGnJ+bzrgfBtrtuEiXIkqqTzpsxnfKW+cREBPDN0XJwDtLZevQhcmi
+j1mBPeqduxm2quBuPitpBa/ACzK5ivYACwGoreLiuGv2uCYMNG1qCWUuV1MUSDoTBAnbow0bQqF
Gw/IhWbOu4ENrr29RF1GhowYhnLn5qHzwJF/Yp5w+/nWeNB49xTpIjcjZkb0wfUM1pFDc55HcbMR
tk1veUEh1FWIYu3Jm3a+lnwFpmhp89s5fA/0tWoMP9VZjGQ06pi8NqjPplURTh9uk82GNsq2GddU
CDcxQKJmS6nbNAvTTh5cDLE0aQkHh8zdZvYn/JVWd6YwUCA8FJ0AAA7hi1yF0nWARRqr3COgbqGO
51OWAGhd9cd5aRqieDuEFFtwIM7XskUHchQm7P2NnuqupzGKWqA7yClf5ZIWalxo9GWzGYkkTnel
1vKyESX86g1GQtQ6VqPwBDWImvoPIzrVdxHeR4VeNm9ueAW4V8qwNBBDs9qg04jbDiXIfkTKGqU8
vU3mGsDiwCREHPbnClSrQG6eNp7+Dm8boDhjo142K5sUQc2UD+uHnA3+YLTotO4p8OQffd3OMIf6
pI/fE2xn1Vd22rnNEzKwjKcrcMBU+Gc9ipt7Yvbgnmc94YEp1N0lsw910sV0/AHXF9s2qy1712ZM
09sCppai+eJn1sauI9PtoXc5QNbsfL7RPDyimitrJdpHHUp1b0AdD51E54/83PzRH7rwjnYjh3CR
T/N77EY4sluaUehEm+beAyKOWnyafHm2jCIArm3G8LvVZku807ovr0J7TN+Fs9vdiDCqA1i5EITC
LnI/81GHh8wyy2WqoYVufJPWt7lKzHs5IAFFv0vMwqFwWR43fRoalISzQc8Eg5tGCVxnzvsTRWNC
9sI2TBEkoqOCmVYh6fQoUrabfKILtx+B2l9E7dpWdLDfnbCirhASNeiDSiFdHKnzdGcltwJsWmtz
B1Ju7LecD7MLGWoF3yTwqo8IDVAYovVoqZDV2V2Q1e3XsW3Bn+moQMRs1068nwNUJBsVNez9OgjJ
x5w6a7cdSoSFSzGO/qknPW9thwG2ILjIK8oDGrbqg4de98wyMWwl0Y71V0B6Hl65ZDL37NDocsJx
kV+YYOm4TcS8It+e8KiS+heZ64TUgmQbLkMDbRhbAae1MLLqLaNpPOnKKMU76uDgmWUt2HAGtf1F
NYm2NkM6mnBjvJBmYDDPtM2LRpXvQSbJ8nwq4szfZEXAnqcsqw7ZijKqPYZJMCPKNoN6sB0NR26W
lSovEl5QqiIhgUmbxepNsik6x0VMiPUbD6Rbk3ziO2vzNXfb4QFPaXafSafhzxYJuKRgUVpvbTYw
6AfCHoH5YDkUb3t/sdDlBCmVcbdIkdlQCgWSns5RRyurjV1EGnPwYb0+/WVioGCO5LLp7G1Ox7Dz
NyB9gpAVo4EKP8ZWglMvlI0DSWqkIqthLFxPkUzEzouafAUs4jxBflpYl71fGedosRtMjypc2Jsj
tVJwCJLePplKKOiQfopgX+UmCg5FYY13Y0SvBGEkm0UihhOXJ0Yje5H5tsx671vFLdnvxgkqTk17
oPxYuc4C2TZy3TQ8AmbhHEHTZ7HvHEE84XvTumG6U5VuLyLoJxaC8a6+tToHEmLuj+ZT2ORlLo9p
GMTtAWo9KSMbHJMWaTVqrNPpEqNeTQjmWEbkgqGnXODysmZD/9ZBE96aJQyuY1MyRtKkn+4iOod0
mmXtADSm+G1TfhsbLAyiKqBYoQIxEdN/wW6hcQtCPQqyXw/xUM8fgzgnRgXliJPsi2Qs841CdQqw
tKrjRwBxeAfnmUYG5aQINcg0arXTpUN0Tg2muftRQPjfEfz/HEHJ6b+fwc8q8/Wx/PkE/vwLP47g
MvxLcNL2yOeRqDufWxY/mo3S/YuVTLmEVj8fzdda899HcMlBm9Mxh216XE4Ar/vfR3DouvwPkqHY
I/ADnML/SbNRPMcG/6fqQ8rV2stYr+/ZgtameFUKHKYUn6zou22YDM6JJ4r+IlsqQcgpokwwHGwb
sN/HdnbqtjpZDpYPCg5LsNm2eHTO48UfT1tHfhwL0ZyCbZ1uscI90IPZydoaryBNzR+swpcYSgz5
bxXSkiMRS9OhW+zlgoMXzKS27m4kGutL+NiqPWOThp03n1o+Bd6NwhzIySskETu6E4dAy6JGyEJH
Md8qjGKXPb4DytvshZEtUtyK9LecU0D1GAWt2wYoqnilN2GMWh15EbK7/TyxrNRYFgtlQOq58QSy
0qeot4UyVm/k6PrnYzOo5rz2E8KBsJ3aG4oEDdRTj80GxawiQh8Ye1e5GcfTgJgjF6kaYnunW8rL
lL8Ly3WiZE7LMHW6aVt3QBWv0rZKxNaeTCOOHBCVexdZBuH8JrOD6jaO5vS07SY3PhuXlG0rubl5
NyIZ8VPO/LIO38u2j+CDaJ6TS0pGljTnni6GjeVYxQPHhsm/yJu6vGoa0FfICJfhempHjHVzN36g
7etkl26YTf1VHtarE7+bMGZ6Zeg9yj423AOklvw9JICyOFOsKvR02dGApzokLcEQuAQgRtToUmlY
MenoIAt3RkzRB3RWiXdak4zeEhTjK6xsuERa/Cz2FObRAdGLjxtXQwOuqszzz+2BI8VWMIhg9Rqq
tvs+6MuA8A5nIKeAi9YbF9tadfBalFM13lsWmFwtBXyEwcm2BobmQAJNPstvJX0LFm9cR1D351XN
mHqFtSV/A694nXo5f9FavnQUuOfdxEnFg03q2g/TSLrQvvB1ar8TJp/jo8Lb8bELhvgxd1Hyg9oI
gVDgJggJVkUX/q6PR6/beMGcu2x4oDpuWTZ6pDXkHHNvFHDP2TSMfCV97197mO8wbREUc02bt1w2
LgsFmRND0zY7C0nzaTQG7nfflQVawjXZKpqB3KG5q6KBY1mtsz0UDv/CsmoBtabxw5NcsgUl6Xhc
7ooFm+0mjV0e1jy54aVGiEmhe8nLU21k2hzEkrkGSsEyvzeeAbaWEjD1FKRgCkGQuf7XxG/7cJP7
k008XDd/kAhqI0AGMzkeSZ9pd4fgnq0qJ85CX4gSfMJlPycyPHpVRWusS6KyPI+N5oTaWFXzrY9g
p+wHt1j9cw3Rbwhs4q488ei7XcInbE+zIMjPIZlA8bTq3s12lUAzSTzBPNigjGwU6ECum/WBqLo6
LEApweZDB8w37SDJpCxVSMOL3TdnZVF8RF2IPGvxB0bbQnPjvd2ta3gfuFfKhoaxHdCsH1Jc2ZI0
VyAmSCUTENuuZ/f+7VL7uOjZUdcffRO333qYKvIAYWK6Tyla35ESQFWBsGAH2o/0V3f0MKGQ5Q/5
h8ZHveiZrDwZsGs7O2d2oolTpYoyc/Qiui+HhX2APkhxISbFZop6kyk6BQazZd/I/p7YyP/Vwn8I
f9YC8n9fh4+PT9WLZXj98R+rsOP+5SGucEI2+4DUMOX9qxAe/MUKKIgAfQ6E9p51PX+vwsDqyWmg
Ck5jkGzZFbL2dx3ckn9h5XHR5xAOCWdNBv9I8vOyCelLWi5oCtZSOBVDj7/2svPi5oHftDgoGZOI
8chSwLxPFYAFUF799EB+IzZ5eaXA9iVLPW1IyPyC4N9wbaX91Crran+G9UvyHfEPW78piVQZllVE
FJkfg/C/NtLXbtF/9hV/X4kNjOLWXOxjr5QaQUqhbeJEBaMp2okMOy8O6bcamb+5HYRcfGcoppAA
ha9y0GMvMI0hBt1L/YZEFEi1LRjiAwruKnujPcam7PUdAeNTjggA8iHP8v1XO6UIlnEfexqgEmoY
VCZdE12GDQekPVk+Aeo/LwO+FS+t2ufxIPtzZGZRS6VjIb62j1RRrsEcnUCVGbfNJoi7JqcgZaBI
0Xiulndhj/h5H82yGBBXlUJcxUmrrzW5Z+aIMTb+QkWNnRHnWaokVgU1DurFXBDDQ9IhdcqRf4RW
ob7DRAVx1tK4GwCADN73lDhGCCB4ZrLbuWi4sJNazleX1A9KvWRnYjoeR49cujoPg7Mo8xWnWSHN
CG2uVB/6DlIXPKlFU55xCtZdYzr/C5IDILiDWG0Jk4bju9VYMR6m1h7uk/YZAZ9FHEwNKboUz8ty
6jadL4uzIfGa8RD55I+UeiyifQ4I4mkgFvPTNBbF9yJPvUt4mTiLLJn0d0jHEcHqWIAZJNkywbza
pt59UFQu0hoAKU9t3/gfIrfQH6LOM0BA3Qhfteg5/m2KsMj6+yDLcrwETlJ090Uw9tcLmsthWxJ8
9Jl+aHkniK7BpdGN2cVqytZbtoFM/R1VunvDFuKpbNP0ibemf4T3QY4AG2VqilEl4GMjEGwfsWIu
+XZx+GZsK04p98WUTXcB9qGRP9yMD6vsxDsWnP3bLXCy4IGDv7wSiKhuUZkNIAaExMkomkF/mkRA
GhKC4+sF+EG1xUGt35WY1JttqQv3ozNMFpJvfJJPaRh2nyYMbx8bjf5nNe+kXyh/te9ahIY5aNpu
vDR6nIDrT4oEVY3zk9DBScU7Z8iLdpPUk/3NHsfsywD1ky0cLBhgDwMBMwILXE9BoURvZrxgwIxd
Zs5ZAwZEYhFJLVxYOfQxnZa1s50oNlW7scCX3Nlh32/zxUDz7c28JhRhvRqoPCzFcjstY3xTFs7w
WY9+8kRfJPbvMIfF971K8ek13VqsMw2uA3QG/cj2orfBIDWdqJb90GiaDkNnIuIeM6f+0jYtm9Ux
9ft7py6ICxX+SAEHO9S4JbAxZ38YYexk/K1sOTuz9BXIl4FdXQf8ja3cUtyVMkguoHiwR18pmmzD
grYAlxDo+TNeNFo2ecPpbDNJTwOYjnLespwr5nsnMvVXLHQ2SGrjUT/FJE7gQkK76oPJhuWDZtpn
q2yr5GvvIs7GZI+AC3uluhVGQpFHYxmBGO8U4UB0t8ytTVC4OAdEiB28046uORLZjH+7pnW7qxfs
l5iLC++hba30S9Cq4gYpFeapuaoZN2EbW5i9ERix6QglVHwALFgu0TcM95TGYL2OvH9fJgbQnczE
PQV4vi3d9eMVRf75WwD9JNj0Da2tbZSUFZRmHQV7aofo7ilpUW7QdNisXYPQ66NhyvxswHtjiO3l
2OyYcExxCgS5fEwLzIbguTk8bex4NtmBaiFtUGiMKNCTZGWAom3i+NGC87skerTjNl2LrOLYKj4Q
kM4POORvE2xqr/r+OE7k9wUe2f0UTqivw0qxnZ7SyJKbEvZxSwr5nN8K+Gj5XrjVeBdzA/pAl3Ih
JFjRozW5IMabYrx/aJU7Rps4QO1/kF7q1VvUsDo4DoAyyR/KBFQeRVvgnIb4iF4HvdAWaCCfCbXc
CG68xntxiPJK33iRY7knwq70PkxrO6AzMMVgazwyYrDYYSlIK4cgsJTSz2ZaK4o4gpif/YhurmxO
5z4wcj84K+SPCqodUhxrvBszFCuoaoEq6zJa1xx0ciN3eRJwuCDoROLNi8eerWkfJg95Hafz2VR6
8bfUmT13H3sYkl2YdcMuzvKa8Bq7m971yqVMRbhUM+8LiGLuCdhHoGUSu2GKXQSz7lY7Q/sFBBHu
/4SMx2In85rJt6UedhKWsQjxW5Zps6t9A/jeLWN26L4PIpLoHQ4CFbq92XFxkg1YoGUwJ2rDJgj5
ort08sRaqBlot8Rf2DgquRjIVcNeE7nnc+9xCtV5SDKOZz47AcISjk5t3GKL6OJLrwjaq07atQTx
TTF7XwXI8PGBIujaFSZPP1iwQZ/Ae013rjNyGEd3ZuljRRDDDXl8abUFLme+1Hp0PsXJQIpwhy0X
KS2xnSS5ZgOhEb3ymyebuW2f94GkpCqi6qnEqXlbGRvqY2GcG5YF/6qtDWdyaxIHYfn+Fyp/tOvp
qxETNKquNyc6GOkAjWod57FhkWkyjzrD6Jfte/ADCYJeb5oPBinHV4I5MZI4dY5V2DdiYdn1mb82
rlObMyvFvbuNlW/HWwxprD5GdMEEYQZresfge2p4GhRzaIrnmwEn64kvSP3FGGVoxoStdz055YoQ
R4Z5gr6JNxI6U/MuHnz/MW2a1t9GyzBe1q6i7Gi5AiehpE5yytrbHvFHEuSMh2v5xNh0HitKksR2
Tg4LSNbPGrMNJ9t5b5cFdd0AXe7DMutYgyxLmQFSM1CdLCEiXPtu5xYAuDhmbYyYMSLWTdg8eAw+
ffCXKr+dKY2hJCWrkzxmas4zb1+8DYc4/Sy69f3IXNkr2gCx8bf4estPfuCkn1XWJkzsg2eduLBQ
DqksonZnGWo62wlkQE7/f2B1GINQAW5sXbAVpd9zlqdngozATH2NI7OHr5FlM/c1spvE30s38mI2
coDjbRFhwUyEqpBn2nVrWNTQLWECoY9+zS1u9Erf0gvNB3xMTaPlaRN77q3wG6SWtmj57mgmti0b
uZgkD2b45mkAsJXD8XDoRRpnjcDJB/pPQ0LSw2iLAG/iIEewIQnzFgOncgBbjOlwk8VCVMc+gLx8
Ps0ra2kafaIfAogn48bxffOeOMcBMhe/AoFfU2vrRtAB1OcDCOGlmPR+opwEOMGD/bYxQH0jRpue
nkprFGo3B8I+y9Yc2M2YUFDBnkoQ07XMeONYSCxxK1rRxQeQLDOg5AnU1k0nFHuitllRJvYiArQJ
tj/QlUdgsstiqqJX9FBykm+ndnU3TY7Kr2iFTI8mqxpiRVkXwb1Af0l2WRbA2xJuxA4y6UjScDvZ
ka5HgQGTvr9+5h6sZMPAGhRW0KUbztypar/2y4BV2VP4OIFUWA7Rg8ZlwYFl0Y7EZdlDvbVapdrt
1DEH29Vsn45E/BrgAD4QI9qCdXMLNKZtL4E+ZyGgpUiGB+3Zw0k+FEmQgBatB73LB0StWA6VfPJp
/KzwSUMnPcpDgVHNUMCS12mXiwOJkmIB7jxoXoxEsQItaVeeSUpyYAJhLuH4SklVd5hyxOCeRCpG
9btr47Dst76MSaWt2FMoUrnZ/m+iiEMI6zK+ZPXU1j5N2E3iBywHQ0zB6rIJXMpDTpTX96QuYpsi
kjkjAWmspvoRMn3Y3Gi3bfybWrg0PYE2sAazr1P62/9KEj9KEo7NofMPNYk+Lb+9UOc9/8LfTiT/
LyUDF8+H42I4Cp8z7P52IjneX7bvuJiKHHYRDlK5f3cHHPxLPj9P0X4tTyBq+HdhYjUpYUNCuMf0
6/Ev/6g78Kx2/88hHu/R+peUHaCvDVeHx3r+/qlckHXINWWRXFpmNI800tHgmK5h+6xijf3PTgv3
BnKJqHYR++x+L0bRL6cqnrJvXtAX86nu2rF8Q738WiW+fihHYr6gWLIWkl/VMIqibOCNgSqY5/od
TCvvoR5J59spN9KAyeLxQzjm4T2nZNCIP313vymfrH/69fOgegKMlprNqtd/+Twwd5LB62eXZZ1Z
B95J74KzK0dUkdo3HZz4p39+ubXpSC8Df78vV0X5T49fFpNEB54RbpbTGKZkWXzJmrT8HAUQbAcf
fOKfr/eynPLj6/75ejSkXlwvs5TpuR52c5YHbdenqmntIxXlZP/nK72sDv19JcEDhNkkPPns8/np
zpLUQExY9KWVl90lR7HiNEvm4frPF/ndQBGQIgKoTIHnv74IooiwZ7N8CV2lAjWUOd8NspMLzMP5
qWDmfOobNe4MTLE37m6tbb0eJiKgpEexcX17Xz3HVoMSLePkMhYyIHy2dOUBRkx8FyxecFdO/XA+
5aQnF1pZpKRUjf9Greq3Tzd01iHq0tJbi50/f4+hD7GCavRlTKbUvjbpeITIZf75u4Bolzkm8LlK
oF4VLTXBWhmRYpdpkHpfenu2jqRYZbeT1smlqE138+cv8xf7BK89snRpO4rLkXvx6npiCmB+ePFl
BgT73Ey1dV+lIr2pbBndBuiiHkJ2a0fwuhzue20Tcs1rQ81rBE3054/ym9eE13H9j9dS/vL1AkBm
horiy67PnW1X53RIMDbjoMCf/I+vhBDbR6C9YtmZc15+kb0BH1lE/sXA/upeTml2asJFHUbOKCd/
vtLzy/BqzNJUpgnMUkMl9dn79dMbKZGqgI2UF4PbVR86HuVnv9bBUx1Cozkb/Vh99KMkWyUuhX70
LDYQO3jCwQ8Z/3+tGv/mzcH9w93SGKG7/Wy/++lTIPvgXKScC1H3c77xWrguVF3dy5rC476wl+Vy
duKChGwIsAWyljccbr+Z311iaanyklvL2rp+8z9dvliSzB+kvKhiHZyIOezQpyY+J+zZHCIySk//
+UN3HV+udrqAfcFzyfmn6+G5SVh5xQUBpE3A2QNcJvKbcJV2NtSxxkFOFyYJ+k+pFTgnVlTKT0ji
+zemi9/Mky8+xatRxkQf+X0tLrwcXBXg6aT53s5pc+yxvJOxPQ/HuQrrY8eh5Y1R95uJynUC21N0
ZJhBni0pP92/KjVS4MW56HB9ndHc906cIRbpG/f3m/fVZVlzaNf4LKbPhuufrtKNBgRM7VxAgun2
kTcQL5kU9harXPeGHdb53aWkJ+TqHrc99mIvB5AfL4PlDc5FSAFewaKYcTtJpNe3LXVoNFS5ii/Z
g4+nqZjFDtgmlGeOVrBuC69578PgufLcRl5N+UgNUSBZfsvw9rsvG88HZgvOATSD1i7HTw8jKNvE
cr3pgmrCfDGidtoTGJHfiHRUxzlOpruFJui3qPLrtwb7uuq9nGEcznVSoeRg6+TgHXlx5TDprKGx
1Lk1p/o6AqcLr9tFvg86AVtEPm5hoSNAUBQaI7jmtwFZoyeoZMqTmiVy3v3jd48AQ4evCJ2NZCe5
PqifHoRcYQ+YXc8HU+WHiPC8SwvNHOc3pK5ROQxH4/sEUeiKYmEI3RF4Y/Txjc+wbuBePRLKxcL1
2cZKijuvH0mGhLfLIdSnylxUzkIMWxxFV16L7cB4fnkXpsSyozcOz2QKjUgat7rxnfRNX/Wv4/b5
SYTYmulzclh9+TCyHheb07vnhH9mXyPl1TvMKqcOrZ9dP8x5DbhwgrnUkQEtael/Dx0z3AewrGin
yOU0sRWZothRroJxdt96qdan8OopCdal9Ygk2C2+fqmcVBQ8QHnuCYpI27BPvF0/z2TC91N/2RSP
pGnme/ZW6LCRpeyLHj4YG/j+nENJ0qxehZkT2r/PcDc/rv3/yr64wSrerUbQ34xlgeqB1iYfy6fc
9vJ5xW43WXq2z7uaRG5aKm5+s6St2ZH4THmurvO7OWzNlmyix0RMq8C8Ck+joZpvE3Qy8o0NyW8W
b8SJzDscjFZIhfeqNZnnGawiT5J+M2rGbaTwGU6Ou+kxq8NO7Or3rjtXd9NAbQNd6NUy+cv2z4/k
16WTj+B5Ae7WdfJ71pn99Do5FBB7Ug7OYaL2CTIiMD+B09ukRYbIIDUa36c/X/B5vvhlWHCtAJ0I
Ts7Xi2daur2dr4TIsm1OXKtLgQtV/sH3cvsWXJnz2ZkC8w0+EXOwttPoFB3SqZ8F+Dh5LLuiCLt/
fODw2DOECnevZJf6ekrJS2AZZsnAUVfLI34XhijZlMjtdey2W9mpGQk/O7oTFZn+jfns16XUc9gb
M4vwKBwWu5cj0kpGV1NGOqezn90RvTMfSyqFbz3zX+cJruIid2Du5Lm/3iCRYFqDC0nOG6xd35Zm
fqfr+ashYHQLEiDlFkG85+iFscZFKQSoyd0UXi23cA0k+NheLg9V54J1K6lP7v88IH5d2fhswFtg
aHgs9eGryTSH8aYMn40HJE6myimu0LKnhwjyMIESPgo/zKjQ7N6axdcn+3IcAiJnxyq4OMZ1+erJ
646mYVlYZ4HSQQ4rJTDdth6HsqTIjnVzl48R5WuiV5Ha/fmOfwEyuIy1YN3XsGtnWX19y1SKZW4P
yXnq6uJCNtT6ipGUWuJLP7Y4eradcpp9sUy38dCo83E03uE5zcVamxy1ZfSNQcCwpXkZv4vT4BgQ
dX+HOI4AzGbAWzLEX4zdv+/HTJ7NWYQUjSr9FuultZ9keAtz/MKOMuuNofzrVIJXXqK2WPcKbNfW
of7TVIIvIe/hOZ+JZn1VcoNEc0kigN4eGVV7SUvkjVPHr+/OesGAocPRI0Cx8vKCDJtCLK46m3xE
DjE2j4PWTfmPJ0gqEExUOP+99Wzz6iI0TUjuyLwzpAXRDaov/EVNGWc4l8iy2YxLYr378+j49V0F
HYHiCcn4ChNaHb4/P0Z0Fcj7fHPWzU26I593IG3GUQfLK8Ubt8bh6NU7QHWKDS+VQr43bvC1kZeU
vB7SkKLurV2AmjFhcNuWMDxCp5GSggkfMIwqYho+CXwYcrMw+GBqjnIoT1UbqUsxgtvfeFYrT+xR
L+KkpT2XbBc69v2+x7V0jV0kpdlZBuqY++EUnRbtXH2FJlp8AyjdNu9mVwAecvs6qrdtk8uPo8n1
xSC7cNUGzMnOx/n76EyujwhFqA4vJmh9XI9RkH8xdY+yr44wcGxc5WRXNV8XyIwE9cdB0A3SW4jh
5K25CxnBhEznXzAALReF0wAOKwMJ7SCtWpjm/YTEYzPWub7x7QXCkgJ1/4VJwHxv8mU615WPfCat
RkKk+7zPv7c1sphdImf1DWVCdsfZ1P7elpO4xfBKrzCpDZFasXCcp7JzYPQS54zQEQSheswqhWlu
IHjpM+E5dDGh4ORyB7Uhwxfg6ts+z7FrAkqx3q+a8uQY5TmuEQJ5obAhDa1ohLgCTHkrJlA2cRTS
l6YRysOrsHV0NdCVDEXkVmSN9c1w9PnQob8hP31SISO4np1h74MrcSC6z5k6wMj+JPq+HHah043N
IUvi5v+zdyY7kitpdn6VRm+0YoHzALR64aTP4THPGyJj4jwZaTSSz6U30IvpY1Sp1LcFCNJei8Kt
vDcjMsOdbvYP53ynAzUaI9A12aGM8LlznJkmqfA4VtA4/GBEFCd9LF2C3wu0nxZ3pr8Z2FFBU+2X
wGbjSAAO0mocpsTjWercaCxOIsmctw8HvRyXsBzjLvI0t0X44dSp2qQ12zCoBdyKEex0uJx9taZi
EwmjRWBqKlyanRPfVGLE6EpuGGvsQsvMWzsmbXOPaEOdhlyMgAbnuUuATGaUekUr+Pt0OqzkLcsZ
p0EokhnxeQyKstnKPoVnTurGp5ObmR3W9cBT1WPDJXGxrMdnPgYaSRe6QwJe4Ih+2FLSz0ert6o3
aqoV7Fp08Yd00vUtqUE0b6psLo4SsOIzhyIBBsk8WY9VbaQorLqJpVE/WV9uzX27IZ/YvhdEjXoR
UXqZjKplRvHDY7msM6qagDA5zc6DQlvx5qcYs7aySLs8hCSpziUUDWc/ZnTLGzGgrzkkowiyU5YG
iA/SImc4QCYYLm08Ppq3QVgyf7Zuhpatq0rSOVnEG3vkxSUJat5CAEQpsIdGSbO0RBNqaY0kjYdH
nvEWA4/G7ER1HphNV+9ZSBEwNwsHOQWpMNRMlQryioQv3y1DgugkIenzENe8AQ366Tohw8vNRw+3
jO2l797iWANvFNfhLhBjcmUrfdmPeoZIRbPz/JkHWbobSPXlDUYbFEWscDGEkZtqw3vEWxcp9BLd
0Wgc6zCJGehGjEUM7f+sAePQp1qcEWPjNG14k8dt5uvxh+0mebu10FwXaKl7POGqq7SBzK92eItB
yg833pCoe/zlJlnxcTZCYOaFTHaa5cfPBJFlaJOgUNqoD3T0+KVNdGwI6QijtegsSqhy8dl4Zi3S
/WjIRlkcRaU3+Gd718PeJbLgsyWqyt6WmIq9bdB6sKWKuUUIM3eNwgtUGmR3QaRfgUyt/5F0NlSA
mXH45+IV5qnSO/8R1iv4E5hPQt80RaFBYoYLJ7YCHn6Ppi8xvdCQbf/goswSUUlsIu4Jw88tBmQ1
J3TZyZratl1r7Swz5VMmC6cIDdUQf1ORFAeWy6jna9bFyxOiKo6dZDSrA/L+BZg1JO0fL7MdQpZs
NzOIaJ20uzyeAFW6KO0c7AscvIRQ9iPacw0HRtc2zZ1r9QItzBSoF51snDfHFOaFV8rBEJ/6+RNv
wHifoDJ8wCtCqptf1eMMhLsGfoxtzyZIwmUHuomtqQ82U2Ck9c5MMu8hoKHFcN+wPwh7tFFXruUs
b4GkBANUvca7WCMyyE1BPo4OFKDVoUVnCsX6OPrsaGebOyVUKra+oPlkZPPUuUNghO20xOkt6YNp
W+1Lny3mB3L66XPyKrnyexE7eXSvtzZwpWcSlNV1YsXozZKq1twt3lsXe7ydIEqEdY/SRTfiuNjB
F9fvdJbVhHCVAe9M4BFeGIoWKyfegN5YNhTm2m3jmwNX31CqA8Tr/AXRvfHNEDa+LVmgzRuwAO49
oYbIYLpl8dioUWsD9eSdi2D/Z96e8h5LKQ5tbknXB1cVLbre/SidKhE1SYo6Qpn4y7YtwC8ZZaAU
kP7wUDZRKxmlnHrHUa+B6l1nix3aK486c6DXLg8KUpn6VA6EYBjEuM5+qj3CFnOwC0sr3UNvTeDG
LgEOFLOuyyeESUQGoS12b3StK8tQVi0EW4DckD8JFvNlWPkInjbYsY0rihZG9bk2EeKjSAhcDfqp
cDaDFgvinSbVfE8sa+rQabhxw3mxBet2bJrjsZ2K+rTkFBIGB95NplinfDsuiV4Gd43c1Lpey9M0
WGYBXdVqcBUYjX/DoCZDamLB4kfB2VrvtkYkVEQxtDRhVyMIJT/RHd8K4WZHZZKKtul+ueLTaGiQ
tivwULNpFl/AT4Y5hIWG6Y+JGGxzYRsADmurkvc9buA84g+H2NpKp/rs3XEi1d5DaHNRszNboBUC
cpu7EqIEO1Xb4kArnU84B8n1sLjtp8oEYG5QusWdXXnaR2MFycg0pQag3WstStpBBgyA4PEjlWE2
3HHgBPmD5Q7TdcUpzx6Lep1LQQ6r0jdOUIkuXUnmifCcBdO/pwhMaBxiAPQ4DSSGF7C0GFwF4mjl
xJpNdg1ans0y01jcwqOBJm9pqOkSpDpxShoBT9SIyxrb5Rb5im7izubRBE6BpgXJGxNz8v8W+ew2
MTXF2GUtczQWUdvSdcRr3xk52YCel0DQ89z0JdOF++X+BorXI2UP85vM/LKlp+4cFoSEwpklCFjb
Ee7dGKPpxW6VIHwWc6X7G6vmFQxjolMxnZPlsBpp5xYmsJcYFES+5bymWkaASOL6DwvROg8zA9dH
C5aSc9TqFgwL7RfRmBUBttnWh5zlhEjQ2vOg5wiKPATBL/ZczN+OUEMboTxxHqc+nR5xnJJhyCST
828xYw8LNxbzGzAOhlqj4Ib4vgMvoziWnGGtsLDXQl5Y0AsmeGWQOpNGYezWwvpCnEbXhlNer3dP
I8Y7D0TKe6URNzsEi33xTQcCjFEO6Z5anjNFqR5QtW3p5rUWqHHZxV1QoPnl37xjlgejm066P20B
fDgXR44jRH296o65bvftoVMzkaRO4+05ZLJ6T2KVvWyTmASNTWymRJLZjR1/x6le3ZOUlG5bu+7k
Zkh8sjV0zHDAWDg+FVFwWuWGdj6D88rR+AU74GVaukNSaxhbUy+KhRJXBj9G37V+OKGuKyJCQnj7
5qAajEtQ2MR1toENYb72BxsqkFyIg5sJ6H2oAZA8tSlftSu48iEik1b+NhLXIDZ273XV2Y+TGbLY
kM1GyGTU+crnJv8zZFOF4cjjPYlcw+8/KHQJdwh6ldS7gUTLPhxbi/eknP1GRsFge68rBcAmUnnB
rtRVDmXaSK2+hZo1k5DnxslLmymDiF9/eZ/8qXi2h9o6+aUE19GaakYzKHx0n2MP/GMqPMRe7dJR
/szjvHeZmcYH0KKPY5MHewvuj0HGMsXW3hKmtq0pvazLxItzJ708yw945Pwr7ltwI3gkkb0jXR4k
tVA+VhAYWGo09+0ixseaDEN3RTRgxfZVMYC3bMa3mQCY+4qHqkRkOKDI0iZJjB/JbwPRN4pLZdPP
BjntC9DWM+uXWANT2jOFICNTkEo32dOXKAceB+jW02VJ+GG2bd+Pb1YyIh3MjcT8mmYiHEI1WS0A
/hnFeWAN4OdmpykJKJqLa7bQ5Y8Hn0FFgFns18Z0cClqmZGbIWjHGjhIPk0KlPk8qYPwCt+gserI
hmhwuwqkwR2MCa2cOiaKwTS4mFgnYRNp4QCgSlN9vsKPLXmixtgpdjGGdCj6ZVxFTpcn3wy1vJHY
P9cdCGvDP+aKHPS1p/T4pzRG8+gQXcjsi/Pobd1IXIN8WB2fVaG2nO91Qhq0OT2D0EE7V/bVDQZv
ieRmsVN1Zfla+bDmuQQHr/MhjZBD4F6WQg/8kNoPRdvYzTb4bZl8pGIVGQKTQ74XpIg4Nr2dOH0Y
GCU+WYUxHgRIBcjbRIe76RL6GTLBXfWzFEKTOzEbWhkiAlEg4uvAe6v5N5dZdf19P5bGbRnz0sCF
wISwgeYRvPaSQ2LX9gOAu3FqAJKQKYL/ckmk9opICTl6Cp7K2imiJ38Kr9Yeu9zPee2kl0HSxz7E
d3LKbC1CV+dFAMlmCi2MjlDIc2q1LSwHljAatoKTI9jK7oQjqZjRRYPxqKhK15rPpszu69QZLwIS
lNq6zURQ+CDT4B1SWN1vmbq0RD8GWoMFH8PQai8gnSXXRXu9cMZr8Ekzuslm0ua3QYDvCkk1Ba+q
mtx/FANOxJ0Bmuzpd1Tz/63z/8o+4j9MraI/w59/+a4Hshav/1Tf//Vfw//+34bvf/n6L8exycT3
Xyz06xf+QyZn/g3GM+NmdHIovxhz8p/+IZPz/4bM1ua2x9mHMItJ1/+Syel/82ydnQijWc+0mQz/
UyZnQ/lm3ca6BIEdpTyOu3//t7+IFPr/9Ov/uA1yfmd3/3EEzHANSQp2UQtbIBa+/zR6JrcD7w35
1rKKk+FxihNcMSGJ36585DOhE1w0t64m3lw9r7N3SZNn3veJJH2K6J/OqAa2JMmQ+19TpxVxvEvb
1mm+VGXhn7lMsV+/LrHIUT9zaWtXBNyJh24QpP+RglvfjuZIX8cn80Ov4/TFT0kqg+UPtvkoMyp7
8rAZL4Yx7TipMsYy/QSEjILAAKVErhzagDayCabMroCN85H3QUQ8jnLJO+gkhnSiBaQLWGmFrBkG
nzi2iW99Q9sayV1my2FFvChkN85EsliPjaEZxauJNlpeJ01gHJAPVe/EmHBS0HxwaxE+ouaftDaY
cJULftjFl+m73ZFJsLFxuFz5mooZF8LEIx+0KBidb4rUdcYrha2tiwwXyUI0YQBbMLM1OLyHPiED
2xsAXT2bMqP+y2AMUBxidrDSLWzByt+55mTJ0C4T9SIzGt7zXKTgUvTBsp/LDsRJBCukQFHfNkTY
qMRpFUHFhUqP6Nm04cIB3HHdGX3uvVpWRtJc2yH/DTGupG7kNMwKOQ3HGQ6IYc9ySznvLDt3dUYj
54fpzSXmJBWrVN2voxESy1fsJTJbAydb8lwoSMMFncB1QBKuvbGweQehZljDIzJsrPLW4pIxRf3b
LNfMNOZHz564eeJp0u1Pz5wSG37ZyOQsoHpNQJOlAJkcJttFJAVi7Y1ndmm/z9EqEchrI+zYeIPM
ec0dg2+sD6m84U1fczJI64pJ4lqU2HREFzJvsUGTbHND1m/CL/EAeEvruxuvN+kHe70InmvIL9nG
oCE9EtGHqj/RPOobqaQP+g/WMo0L93uxNw0eCpwaPQgcl8DHL4Z4PHRlUKLjzxgmzOCLuRY2JcBj
72zbAA/paJYAjqJa/rQTDKBw1uOAISta6GHTZNnarLf29O5r5nRvCN3707ewBze+m2TZZizIQdsp
qVOxz5ZVOKijx/hPbgQLgcVcDs9ZN1hd6Jt4ZiDH8z26duxfcxCFwAvLZI2y6okM6UwAjA0rlo9k
yuyHWfkI+tUoJtTgPcxK0aPj3mAgtfZ9hhbkwKvT/iiguvxkWI+fACBWz/xOBNdkkhMpOMrhAQ2M
dVUF+WppIJ/bZNRag1djhI1jdCJpDHINc9O3HPzdDI0BFjwvaympydPW/DE6s8G4xoc7RM1h4jBg
SuVC5VLDSzK7OSz+fnDyXWkUEAswC5bXGhI6osHzof8sFk+/KYlb8qK5Y4AejiWYChK3E7UTXaHr
VCc9hbDU2GrFrJb/sE7KtS2FjZg3nT3kZ9CY9IcagWIlE7xM8V6gTiaFGRjdyfXq+U1X/fBhTR6N
iIXK4HqxhxE4v78gStQLZvD0n3r1BGgCsEfv1KV/TBIxXBWapn+UAc4HrmXP6yJSq6o7/lCoaqWo
ab0c2Og3Ji3Fixn7Dg+dMXRnhPDuRzN3qzGg4+twz6Xzc4816rrv4vaBxmWVBZAC9pSM+nDvxbZ1
npquJFvWLIxd42VorLwqla9ZpXzseMlcd6cWo1O/IyfceSvzwcuPcafFzGO1uLqTRYXZjgwduEpW
5xNN3XZ6d/EC+AVRrZfadUfOehMltGkPFfNgFZnciA8SkDf9pjNUZ37uRuCaSxmI8Ucx5GSHreWh
n3eiujheVbxJ4dfPnYbvCG7mqIjVVK5OHnhCTPrWMfLsqh04sUKXFfyAS6iBH2Q1OiYW3KnJh2Yx
q6OPST2P3DZNfBaiyucrT3rk64GRKr+nKnUmYJJoUJgLcpYu2TyyMpXqlnQebESy4W+9MV1iYzcT
OPdP05sYsqgCIyaLihmXgktUDRiGRLqkVzH68bZWHft7sweGRohW3jHbFWbxY7aufLNyDctYDPuT
1PNEDxiv4rZ/JOwBJNyQJtLbYLAwL4zuO9J9fWLWNjmlwNNQxNY9TwpTb6YK1lcQN0rQ/9XpawLa
87GadLBkMZDGZyIDimPhkXe3MQnvyTb5OmKvVMdoxlwH76p0Zm9v2CRKbOTfB/SZK5/BZzC2hwpL
6T+wwLZ5q5nsD+uMX/6O+0k/Y/Rf0d6Tkmb0oB3z3/UA/9/BauN7bcLYYl0h1H2lTsQPBekelqt5
i56WdUNsY24G7sgWov5dSPS/ywnxu6goNH1lia3ri8DiMIfaRUwgduiaFYfTcg9OjpBLOPwuQZTv
zyzc191I69LQM5TwJ9R7v+sTPKysUoap1L0NE3hEz8u6bfF6IU7luoFh5MbgpDbKmE7wd1Vj2Zj3
tv7vCqfSFdypwh2Wae//rnoGMO5wd34XQTVwnidj3Q4RaJk/Kpf0wM0SlPxkw+9OiUOJZQbfECOu
MTDdOLPEIleXop99VI2r+LGqRj4G01yBWmG6xwZLtSnbLAD18btGCNm4qS3T+RP/br5o49mCNaTy
fbAQYjeGeI09Ga+5eRfbnfHDnCO/N4bM+4atw26t6uPiJ/3duJHUxCS8XRdxrSHFj7cu5/zfPZ0C
n3o7/m7vKGeWNZ04Z6snq2Hs6Yb75SrpzeLT/90AjlbvbI3fvWCcVyLY4TuYJRZbVodDIwfFq+nz
4IzrctH2NEttCf9k52j+7h/9dRXZ4/BMI7UuKJUjiyt4ANYzt56Xn3nyiehMqmW4pEk7tPuycYLq
HIA0kXtR1NOd8oPlCxkWHX4bMHxg0+HeWGZLrYTfqa9DFhJsdjynt7/bQNguHMt0ugEQ10+Rw7nH
ho0Eswrkb00AdUoQKyHzbq4/DBL83kmmRhvsG20Apwut0omcuRQ3LOOBimU8QxanTGJc50zQLhjM
XM7aymMVVLnGQgrn6MPbnVPVETVHFO2bCTThLJp8fMpaT/mh5tX5vq4WwH81Twxl6Oi1t6KgdIg4
8GrEk16rzr005RtTSL/jvEzUmbgDmygat2ay7cKvbOAYcF3uEyQaL5XC/4wMW2pX+QSrHYvn3PwR
AT/USdRGe5wK3frjDULcJzUEqGgcbEiMRIr5D50zJyy5GsJHN42tpS6fKwH+B/amvcNQ5zhndsDq
yRB28BPMNYzEIENHt7UmpIN725YjsYfMf96dXDKIXwYNGBW5j+bJM3z1lgCg1Cim2vqx45x5cIaB
GYtf22A4LUiPWwCF+aHU9C2sU09uZldzj/pglt/osvNHWcSafiisQXuZ2MG+wDsMzm4/Ms8eSgP4
LHe5pLFNXEVeTbmoU4Jfnx9FJtXZmHKPSjLxte+8dakNWhB2QVT4gtB6LyWId5fYmYDLWMxaOKEQ
TXaBMtgWMrCT98RGYyFnAbFcgWRMpmhc4l6P0nzEiRjIRccV78ZxteurTuws8ojcndM3LeAlKM63
gu05xE5Vj6RamxnlftBlcCCKMXGh63U+d8b/ezd9037XD4P4/h4uf9p/WxvxT/bPIkvS4d//+ks6
vX/06Wt3+pdfbH871Tv5Leb7716WfOnfm8T1d/7f/sd/9LuPc0u/+9lIOFV8twQ4wl/a3TXV4J8S
xPX7/6VPvvom1SVt/rev+HuDDBMO1YWLftxFC8exiVzx7/2x6f0NSSCaNAvVic8/EE39g26jmf7f
kOGaq50KDZGPIvef/bFm6VjMCLVit6Zjm0U78j9/9H+oI/9P/TGMlL8KXTFrOBzPq1vEspD1mP9Z
L4mO3+/0yaMBZDIcdTk1uKzZ3SXAzQpL6tdtJe4NWxCHMBKGqZsENjbypFvde1eNx9gdD11PDhau
Frl3CrLWCQXfNGYiw86b0pDJUSSD4C5jwVUEfDz+NKhAEmb7XZKfZj6QpXRfKFJIcbGHaxbDjzNV
3o3WdztvsPIw8L78zvocK5Plt0IQXA236JCO45C/JzaHUgExDpAmsdL1UAcbxvzIcS2Bl9KN2Hoi
eYzxzhOUd0PW0pl+AviD3VzVJSBLrb91GdCGbmowhO+WI+NXxr0mFAe7SPHOgU/BkP3tWMv7TApk
keMs7TO167Txp5tctUO0wd5y+cgLcrwKfixtDTS1mdY7Xv6OB0pGriV2Xlr/sOttQKzJVyGqWznT
QwR6T4lFwmR2ZTvJMUufJ60b33Pd6daemZxIB54YNweRYjN/zXEgWotyrNUea0J9a8zDE+ySDQDx
e79ws7Al8ChsF0J0nW55dUt2BuVk73WvJhFwhQRMqPB6GmRL9jd1ptYg5BscjuFCPHBvNBcibSCf
NvXbIrgmgnaCFZd4KDnqi7OK9AwhyDrVmhYXmqnvGAfk+8Wr7jCgbMui3I++mCDt3NlxebFExUbC
OvUCpIKntQ9C5vdAJlJOPK3ZuQRSK1vzPtFm3mreKvLywXIiKyJXwEKdjzxqr5Vsu0bmTixWKrDe
fFbYV/s6iObm0Ffldck00rBaeVsL60EjguOhEEGyqeMEe60K6j2+x2diUs520Tx0YunAxUJlAdgR
OoDDfkj8JsB2dtVhRM3HTnmOnzPfAMptcdjSwVpHc1YnmecEDk1pHFZrFvYsyGLPnQlhSmLvXbe/
FSL+6Qzr4sr2pS5qEYnGJrDFYTGZdSZ7znRn4uRnCdDPOy12pjDvgksm5sMMqDtyBu+UVuvic5bX
s6ezDW5HfQdRX7url/HezoZl15UeVJkGlULTpa8FtaRl+kxiisyeVk/0VSFh5JbBk66VF69M513a
6YKPoDld23V1LBdHRrPM3xSRs4DcunGrW+1zQY+0oVe9Vq3yQg2VzRZ8KZsSeWE+k5DC5ubbzNIP
QX4pbVDZMfue45Aj+a5kB8HAVobJrrY5a3kHdLl35z2m5SrKQLMiAijHDTiMT0Ihq02dCYgug+ZE
Qy7PjKKeXLaa0aCqQ9XRWKkUNVhCeebl02dA5Oc4SBA4KD4YYmuhCa3Dm7qNpk3dWmB8UOTQwGRF
CP69jiqYAvxZAFkz4rELObOnKrdpeZMxH9jSJjHguqtjbRcE7zAjmaF3+WeirkZJLW9l4ja1wVWW
OVWtbYv6ij0Sg3SZe8mDZY7tAdp/d8X934dO0FZbsah+Z+pJStRneRRAD99Lt1W72YiNVxWIB0fO
bBtnEH2T7DZAOJzrdgjQG0xOzYVEXSNrSAmME4F4atMSzgyAEE2w5q2COqq95sZayGldkhN0m+mA
I7w4jUa95UFob1WgnecWlEEZfC3e+Jjn6rkkjlNAhI4qZMCZO8KcZ5tJPHZ8kwCOshfzZI/zuW+g
B7sOdbFLoDBx4VADlkY79EOhQxtQat83VnUxZytkECTDLMnCqlGHRhtvcT2R+FpwFuhJeZCK/iSh
AJSOf+oLDYjWmna1oE+QlfbaEdG5MbtR/ybi2Udtz/nVmn7+QUxwddJraNfGNEX+IqYrvazp31Y5
QQ9FIsr7ydlZUGDmsX5wvJKN/H0zW4daaSYQecqV0i63w0jrtRTl/BiXR3K2Ob+lMQ7Ps2v2Fy0x
TzUE/0XWp3RWvb5h4NyzM5sA5ju22knytbgfgK0rY2k/9YLjcy7c4lK46Y3WTglTl4EmXaYsPtk3
7HQvuVHVH7Oo9XWwSBlfzNcAKtw/o2y/smTo9wLjRWgPzoEpwSFttJ0a9KiJm2XT9orW2T2pZAnx
ilxrWfa8OORDp2N1AjV+zEBXER/dwnvueX/iFBT18D17PskeSXl2Yz8+kjvXbaZkIXceSkIx1tta
547p5CUb/CdBFIiS8dkt1JdOmvSSQP5yhhAoc3ppE/1b9OWT4cXLtrHRHDMkJsXOKasdfG1jk6UA
hLIR5QqKrl1QE9rQ9xZgJ8IADmmKZtsSEvGyVPf2CKMzWxjJrLztRvwpdNgWNTm6lM2FuyMOo7gE
ATfQuKi3zIvRNnq9Yey7nmwDfUB+OQHs3s0C/HKuyRkRjasfzFpbXqdlefHdNcpWQdxyWsYkFvND
6j5UOpODmTOtp/xUNmn+keXJuKPxq/mNHv4Tjxn/BjIS2E83kx96apGNPKvi0OsDU2MDf3Zmm/Oz
QwfyNhPocacTGcBqlrxu58ZJdrPjdGCZ4MKO+oOl2S9VXfSPuT5CSvde6tYZjk3c2bt0ADqVqBJy
bsNJqxXesHVKJrK9it+DHjmI1zI0S2jRI7tLd33QnCbGZJu6+0ZmY13FdB/RojEuYFv9J2cZPNae
c6wMTX/okuEFxCYXmnePBXA/YDh8sZMmCx2hXdCu1Bu2o/VJGQOs2c4Yo7bnyiwRYRyRU+/ImgH7
xmYB8B5Zfqc00I9yMjdI68LGJISB5M1DFjuR8EiFapew8JqrioCZnLbLLp1nL+uuYgJVavZ2VcdG
QqG2nWOj35VjZoWIFg5zYTxWASguWSmYYOxb23hSN+ht9iD4+VBCMGthJxZzF+odM+pVXDo3V7pE
o56kdJd8IoL4hhjjByQ+7zNbgWCeuGAFuGJ9RwbYU1+yazSQ+y5o2QOmQC5b/U1Aw4L0ZVVNEwSC
0idWoVNqUe6KsLLNb7Mv9425pl5GWTBvZgmMtkgOtnNLIPVnabbnpXcjplxVCGU5bBM+DcCTPS3Z
V7E8xPDnQZ3sS+J5qL120nVPdNv+nggV3vJaK3bZnKDktJd7fFjXcPyaTcHYap9My1NjuDp/E+Uw
85fy0En17BtM3Oz5d1rl3khYs62jfySeezZ0LrV+Xn5GyD4ZsTg7h5CNuO4PbAqO5Njc8GRT90FF
Wpjcu13AvhOKYWUfxj6+ZFJ8iP6eedQDWKCo6Ekvth6apnwb2+SlRvTZDv5uDMRx0cqrKtGOXqdf
k4ceTaQERg3YvWhShJkx9N5NfUdMu5h/msJ/dUruKw6Iwu3eGk9823p8dhQ9fNxc9Vm5V6bca5m9
TwuQMFm7Lxz1NbKgYFV9Gu3xbekOsE/2ZOlR0tN7VsGVVVwHi3onyOaqT650+z5xl7tmCs6yZLZv
9zs/zTciFVcueOUuJtkgNTjNmkmchU2BMyfyIovsj0vBW0zEQAlSMiKnrT/Mzjy4vRa1xWVY2jhk
c+dEgY9wsq35NrPu/sB6TliqEIM6M1CHCXTpuuamscTdqIEiypOLC7QO2cGtM1XbRdxbvTZt9Ioc
D7O8YVA5oA0yL8idowEYVKQ0bpROB1bFqXMMICtSrcVu+YK/Co4zAqTeOHum95zZ6ROcAQZvCUDH
mbj3kozbMpO3jaG/ZQTRRGNDkjw7nsMsrRtv/kT1HIFEhN7UzwjYwTBN7Avr4HlA5Bl2gzzNQt9N
MCD30tLu2Fc9de2rN7lXKL8/eZIAbQ3FvQkObgN3h2FHiSZapeqDYSP0/7bYmaVtX+oZSFfdVodl
Mq/zXL9V7rJFu49WjDQiZGOKcAnv280AgQs5P2dasLYVaQh3l48Bj+UYvE0UTDn3mV4DG2SbskxP
lufuW42MEyfICLiyx/uaqCTMtTfdtKo65LngIky1FRg0cg/IyTnGTPUM130bxxs0bddzIi6W5gPe
jKNCWK8rYsjg2OPiEJj3zPZJLh8FKnsHs5N1zjTnVkemCWJrPfbu0KQf+kVeGiSKd8y2vqYG2ITu
PJM84oSOPW8xQ0CiJhM91q4dlW0LfzihutzOWYuFsrmbkNo1LamKHqG//aHKASln+nSdGM4mVfFN
2zF56UfrxM1Ny4aCfshShIP8b4p3mSGPRuZtmL591cAyw7RvjlpjQR0rPTPUVH8pW22fmSituvRA
ZNp74WsvonVD0mSnnaNDrvKFmYVIaP6UlTpqKrl2BHXponHYWPTqm6xXKCdT8k+Y3241nTVToUam
22n7o+XDpjUBMKKovS803996Bqd55o1D5A3KOhrKR4HqQfor/ce4Td9a1Fh5P8qrxDCv2657Hpey
CierVqe2cuMwnp1nG9U6WaUAoS0r/xha+6HRrGZP1CBeSgpKcuy7PeXp0zjOBMfH3VGr0ICwoXrF
A/BWFWi+qeIZvYMKDD2IltUafSWWST/FDQ7BBdA4kQjuR6Kae72vnciQ/q3I2Xeb8SoUa3p2ShIR
kntd2Dr8xxyp+CLYXJRkU23j2HJJqQp6XPrJm+ZyDGhEkx48P1X7HBsrGRXTstdBhO+ysUHl2FYI
YIJJwWXL61NJxAwveRa/GEbymHbMwmmSp/W7yZuCkxgFKlUyMj2IcBmoVY05nW6yEvdJXGOSLs8o
cJZQg83JJiqclHlf++0mdYNtnPXtpsTVEkDitjy0OgKpXtkYWPCwfgAkLdqdUHF98TKTjqLLrcjz
Oy0iv3PYpW4ThG6DAjobSXLhJSVAbjrOZkUjmVCtTM10O8QM+BN3jK/Q0PfVxmo182zLut61Vdux
nlG47LzWOJoo3eGzdyXAmqk6ulpG1Mb0SSBI6Ov5boZLnhWrEM6/UkR2Bb15cp3qx+eutebqPSUu
6tDMDfLULmerOJnje5Wp5zivj5qNEho55GkBfhliEdmUunVljjzmU22eqU/JwuCsigT2tgIUWavZ
V6jKg6NnNI/SaPVgiw6WZ1xp7PezttJY0a4CTt5Nk3q48Xdk3WV/jPJ/sHcmu3Ij2Zb9lYc3Lgqk
kcZmUBOn03u/fSdNiNtI7PueX1+Limx0byqlUo7qAQUEEoGMUNCdbjQeO2fvtUfNG5M+3TocsHFA
04gZMQkx0a8nZz/oVH6eyjjFrW2kVEjzl93DP8aBf54aXV/V1Wy6AVAx6jrx0PnhC7OjtTZqx97K
LwxWot2EzwFLLbeUu8hurLVWJp4PaoMR5ybM6wBzGCHXqAtqfwLY3PJajlGvrxI/qV3pEzFgMNrq
gh14SkDsBGzWzrQpNWUE0RHVbiHzo6bpFzGlWibyQz1EXw0n8eCZHpxI30EyO5J8RBP3fmzsq34A
PC/kprPpXRNP1neIqqC009RvvvigIeGWv8CSvajS8JhOnwOrI09tutaN4JJm+BMa11OZVPDecb4W
0s3wkMABuoav6erRtMLcHq5By52MIr7SGVeWTXcV9I9q0RDMlppHAuAYc3Ma6RtqRZqNBrdz8L05
LgOOXdoVc9DZRasIczlWlzJpPsywFugT4TMxJ4/pJyo7ThkskVnZpOWEFcESL01GKFmsXZAvuUlt
89wzDrDbzGt0460dSDRkWqEIeh4RKUEaxNi6sDmnU/PN+iImtUOOGWQsRWTCMku0qo3h87DnzM5T
BOOkdng+nTSnc05VXF3DNd0WQweeWk885BBIz6M7p5qOMwNUBnH6yqc3uzKIjC1xq9u9s8sNts6w
D7ZzBLCeCaRnklWTaWgNy+SgGv51PUVf5ym71cYhXHfq/M2J/Bs7jJ6dvH5KrEOiC3jS1rxReaWD
o7xRRcYoTmg3Co50qq30QRQVPMOKHkdacjToINr1AkKehmckCL81SV3sCZlwzoz2JnpFsd5tYoAo
dZRQ2oZ1yqOoR7e4+QhqIC3qwTKn2z4tv+kptOgxuwyH+kzziZlDFpq8d3TEiBbj6a1QqaFECbHU
k6RYhjP5kr1h3TKOuY2j9Kkni+8/GAaco9e6aIpv7fvO//eW9j/HAv/TRgYwiH41Mnh8TtOo+a/n
/O2/NsSf5CAOvn6fZ+zf/vd/f/+zf1PXQTH4xNEAgDrO/e9ZsH+fHiiMBUib0ZhjoXD75+RA0z8J
DTYGYjweXF0I9G5/J+ND2kdbt3iSpckflPKPyPjaR2MpfXT8jri8VFJqTGYV702swWAh59LU9j7u
8NAww6QZO+aRtfRVx27rYD1BPBwEiUewef9SdTX0AVtFDdvqJizwqq0u0lHPbrQJQ1hj6b/j3H80
K/MBLSLL+XAIU0kEWL7AD2blYeSj17bZ3ldxe1VqojuQumgzL8gqY//D7/cT6sRHm/L3S1lLlBA8
QGIHliHLD5dqewsnuZzb+0mZCrdjFucFahj/Brex/LDv/Oy27qj42YHYG4JfchFb/niZYa6QKrZZ
+NCzeW0hE+HhD4ersSLqhHjnaqMOXUmLiTrgDuuyfTFXyjmp02NNAxXtW5DvtS6hHUai2m1mc8cV
jVdePE2QXf0bts3ymPRxuSPhBTpaE/rbsFuOUmC1tr++Y9piqv5RmLl8F5aNgF7M/It65/13mVD2
4NpowgfLUsI3q8v1K0RTCKHpb23MqIRf3GmHEefLujOmcov6CYMl6sKsRTxRl/MWGTbhwt2dNPrY
g9Ia/fWj/n/p73+L5W7/+5Hm7df65X1u9fc/8LeJpv5JZc+xbJKrEfeKRQz810RTsz/xwofpp/LP
TCQd/9iWDLYxVq5lfffxw2FgYf9tVzLEJ6zwhuEA9oKoKWBG/sk8EyrOu3UFboFDtQ4qgAd+2ZS0
D+sqiprIsQIiZFD49zhkE8XrkWgc0DwWz3qhdY+CKeIKQzQqmGn8ojuF4oairS/txqdwHiLjxa/o
iDlxZO+ZoYSPYTzPG9nNxqmNY2YYIeb9Jy0umm2ZkuR8hHmRXzmiTU9D0UTfQCKr1woxCXsHrcEF
2BWCFJuhutBo0DOrGbor1M/teWRU9NAspvV8IMcZoYlci9FSvKSNGq92hHIft+S2oisN9q02ZcgK
IzLxZnWsrm05GbfG8hjoShK/FNjqEAxEw14n/XQ3lll7PUzDfMQOIHdjG4rTHGq0uZo520gzTE5F
M5yFVK9wr3vwL25SzUfkKrRbMoVsFwQzJUc7dtwG3X92KGOooKm3fYyfRjTh/y/Fmz9kfPYggune
uZiDDnVmVQyB201Mkh+utvAgdMaiwf0A40aRab0LAzkw+0STkDmoUdFFDMNjXvfTKc9tOl561361
h9LYRmma7RCs6Ks0Y0KnIoJ5AUSg3hod3iVlMu6KOR8+J76jM381lO3AzG4IqaWFIbdoMfNrPyvE
eS7s8n7I1cmzzM7cWUww7oKIw1FtlgHFuZoONHIGVCVJ0z20OqA7dwjJvAqMyrkEafTaVZmnUdav
Mob1KywluovTnTLWav3XLuzDbVbp7bVOCBiI+0DZln5HP7Y0LqXiG6hj2iuraZ+UHi1fiG1hmIQk
aMzYE8G5Hg38zTLsLirm1wj5HMKiVDdIuhdLj25kQp2JXe6s+qI82GSduS0ovI1uxPhk5Xxs+/FY
cWrDfeGmZf0S4qVYBR0v3Tzr73thEyuAnD08KRWWQSz2JR+i0WDciNwsSLa19zhjugesRslRC+3h
6NvcHfra84rYAjKppkzfqH0J2Z+GIXACb6jeRGVnNGDngfljMNJTPJDZyKdu9IbElULZcspb2+3M
7Q19/4D+2htpxJ1rB1ER8Yzx2iTUF4+ysSKN137VBsp+vNa+WCGBtNe9pnVX04D+2ST2yyb+ebKm
bYSHaIXWiQgW0mu0WvFUo4dqsHhosbjnM5O6qhh3lYiqg+idr3Wt7Wky4ReN26NGYsBq1CdQ4K01
nsN+LL2adn9PQrbXD/GxF7iH5k7ywCHW9oD2HPUy0g49WnzAC+pG1vgNF5XcPip1/aIpyoumt43r
kRy+Fe/O10ap761+KC41W17nJK3jUMHTMvUZHisNVx2vumeMrsmpMaP4plYx+8STrq4to3CFQSd6
TM0U7bY52a5qMN7lQaifZ6xwvMFtYwvXylr1UiEKwqev3/KNyjj8LNJM5f2oDQ+dqRubjq7XbSfk
ubUV7hVMhbzMDxaFV5rr32KCzWojjM6wgI2HJJ8Z2KWXsDSqNTpF6jjbwMA0DK/5hIIT/5H+QEe0
QqhuR0enUjYcFMdVayhPiIXUTV4n81qtwzsiENZmG9ENmui3aDxNa5t2xSlC8/9gTDh446J+TcP4
Wuayu4oag76LcVZ0bU9z9aEgewBHNBkZVlve+mH0lk/Ws9VVF5Lzy4UVhZAgUtokWeHviDWND7Js
ma50Zr1n0tQv4lvmlbaugNlW8pWYGRz6Y5q84gevT1GQqathTOdvUMwTZvvpQFKpGRyTyGq2XYI0
BrWZihEgj4lY0wzl0OKx3DSY0lZxmPI8VeXA4Tuft/WE/CAcYrkZQ0AbBk7YNeEmWLdRa7sDWYye
mRUX84CyzzT7HAmXpq0DSqHjBIzk6PRKeDNZlvgSFYZM1hYxxBc9YYqXjR8djCC59gVBgV6aMm8L
jPmcJpPrOzaRLkj9wzfSEswdJuv4KZDRdGHVDSytJJNfR362QzJD/+mh9hOAMb6AMLSfQQdVKxRl
R77IbK3TQKyDKtjbvIoIa5HavsbNdptZ0VvbatbaKCp9TYwEgawtyoNSZOlDM2VL9jc8uZrE+oD5
07VS9BrznNhBfRPP5pMySrSgTua15fhlUXATBUzaTDxj72cbuABb8ToQxYd8ps3cSrHStRqmnCon
qxLPZUh7DC27aFBfhLTiCUAIyc/TA30zJimmA5FX1U0+E1/oNkOq2NsG9+7eVkbls96X+YnyI0Gy
VObWnaEqNmNd5LifLUUROwcC3VWrdP3ecZLihClWWTcGAueViGi7rDAy1ic9bgKaR34t6Nfzkurp
wkGTyLr+pVNJiWAq0/s7EuDLB6Ha8g4zecv8tQwZfDUpuXe7tvCV5woWyE0vRH0LSYLkojJsbilF
CDwakE7ivcfxR879ytd0OnLgP1aFI8dLU1rzua+a7hAmaUk+3ZzcF4b2UFSIFXnlFUe0OPohYk7+
zP0IeQGbVfF1mkmoheXffQv4l6Y150793proXq+IH2CH7IMY70etXyX5toB16o4Y2m9EJ73KXnRS
jhqtQcvcxmjFAdBfVLV/wyiTN3Hhu4hlSQBw0ntzSv1vUT2Ym0lHJNBM21S+2XhlFBX0gIEEOZpf
VLHBk52sSfqgJZU4/nQZpYV/omtI7HM87PGPP9u9gkYqY6NAG6yUL3jD9KNedM5VFjQtg20UjC4+
qY7xQ/Fc9b6yZu6Dw1v6Z1lxrLR4RgcAKsJp+60yB/Le0LphTRmhn9WU7Zg+R7BZZFy20GcPNEBz
DWDavEcXQ+0WtGN1G1u68OzYcK7CIG+eo7qTSOl5zfipqDxSy00iRWN7H5JQwBKk+gvast60iPq/
mlbzMqXWfA9YA/0ApqktLSLjTU4yXJLnG96ghJp0NUVaU2lHWczprSR8i/SAClXQaIJUmbutFWov
FsR/jLLdGjVRflGgBQa7UbGrF/74GQH9TkUBJXgupZKTvlhssZazSzo5vV9hqA+MrWgp5ZMIjryE
8q/EPFClzHiDZlEGmPqXSPA4jYO3qkmeEXLUlyLTkMKP8oTbJr+RJVMMwxDhFQY+8bmq+/6YM2C4
D8xUvxy6ttmZ6ZSvG7K2GYWiJKvSlhyq3CFGssEKMye6fj8EaUEpkFf2N5oAixFeVuZWlJSzRRGs
MZm5IWKyxOxJDTqoSYfxItvKYdGHG+Yu883Ii5UwvQqKOjwQcVvvxqbFLdXEwaVq9x1jxTkrPUsQ
aaQFtFUlb9g96efX3TxZjxIR/gWH4xmjasH0Kuq14p7GRYPaLms6lYnI5CDExc2jeLQ2eezofodi
rcRfhinZ6Uq7jEdunfQU4XwB6jGaPBU04rYdCRcMnWHC7OO0176RydDsSrqyVqS3ByA6+hGX0gIg
MMcdXpZsX9dlt8c8Kx4rW2O+TCG8YOhB47goPVDXZBXYJ5suotcBipqYfDKu6FPpn4KuSZj6qfTz
PRH52qE2xhZn7GwQn2X1VsJTaigUZ2IK0KQs6zwqpvJLPUaKhy5hG0R58TS0KcPSeYrQHbDwA6w5
2L+oorQQzgZBmCAtsEbwoCEMT2qE0tSfukdYdoMGfhiQbFWWo9w5tTLNewU4A7SMifjX2MF0XjYV
Cvq0IebOAMP1ONTg2EArkJlNLg09SSvq1DsgQAKPSRP1yADwYGqg9lSfG6faDxroES8M8TD4pW7d
TWagkpLjBMnNGOvZVrF9axPA4lirk1FVi9xa55cnJKsvF2Q7+ONyBUJvuksHi+miHmeX7P/BJg4o
5Jq2Vj0GV9Glr1SoVQJZP4t45IFW4qT4JpRmfk4KGaALQ7uJs+iub4qlj+/UyDtyCg2jpZoTsYbZ
ywf3q4Q7OU8mJkDeSTq2nAsAJPUhzsv0TnAMYGPiUMcLxHAznQ+A3cH4wt3p9qTKoz/FzeEWjTJs
ytKSJ7/pPpe6Ktep3Sp0aLtI7qTWz3vsqWx5uWrmlxOapB2DDIBEJeKdtsYtXehKf9B4OR+QcNP5
UDJ1bdeFchwUO2CcaM6brrHVI8G5ipf5tb7P47DaxdJQvDCuchgkVpc9NVMp93FJD4xUGoc3iDaR
D5VNO/4vXqhqzaFlSyax9mjCkWAWgllDrZwXkmSKlZgQ1vcDkroWO42yRCSagnNyhk3WAjqGsiVr
jekyZPjjYulArYBL7NgjtGhu51C/GWrjYDex9GAfXnFg+NI5b/oY7EXcbPtucPZRhqAgwZESqcNN
wYmPmKTBOTihzojJN6I96yNx23Zon/ign/0eTyCg+0dlwJ2e0OV7NhPjK3jmYw+2151TwAvZvIFP
eibQC1KBX4L8ssJvOhCOlaIybTU6wYHB6aVnxdnjaJfWaTS6B6dRBJkvDDWczD/PIcDGZOiyixrm
MTtQau/Ad9k+GoNQni2kISuigtaxpaj3pcCG1XCoWNH8yteLtHoN+n415sRKMYxckaqjnxjKbaNc
y48YF129TjbjnMvbGggT2tBi3laa/Nz7of3ERpjshij5ksPrQ2hFgJ3hxpGmPKj5BIdBFHLLT0/M
h2jkbmn8DT0nRLY2bKWx03JW4EC/QryYAxDy0TQYAfNaFMMqGpkygBxZqT1kXLXw14yI4y1/sPJm
Z7wlS+p1IgtzHSqtgQcp7tZxX/pXlSU571TWA+BjSD8WVKI9ydXdSwyIx5VaK/GNVbqnlyNJHHG5
6sWoXFhW79wIB333okU7VxyM7K49R0mWXkq6Nke9isxNNXUmwmCDACZsRwMNyfWoczrSm+lM/DKK
ZEmBWbUXTuW8xh1G12oC0JOB5xiZdRKrLLBDVQ7RSNV9J5XbWilqV1ToqUOt+dy26Hw5VLJeodmv
KvRpq6pfJOxGYPMNeSExZ/fR7R96Oc2XwK6/zIbaE/DTk7jecwDl8KLiJm+onKMLwaB3Py7D05L/
hrCjLYykENpZXbo0V4RHPvc2Ii6slPSFhUruZdBy9b7RnqOWCZ46iS+xrGwvx2Iczzqc4r7zXUBW
ucevp1MRYw21+6z1bBvpcpHO11qX31Zata9KFpkiJ5SrZJa5FTFkGy0wTrxvV77i3ybiRRFDv6X/
Om2asY5exuD7UNM/pL31xWr6I55vr4JyuR0Ws1aRaLe8K5pL4IflIbOYEKrA44JuAD/tk45k+flO
wD9BQUFsOEESICi8CX8hSLhphzBARSeGnUnT2HCCPN+H9PsQrMh+y3KT17VpRNvU9ydMLOW0JhDs
cXBkd9mgpmTQbj85BrtKXsTbxMc/Fyf+OaEe3xHnWIN+Qv6hZ839kMXIEONTkdVvJSxcTy0QqAS0
77YTisQD0OEnXcvr66yx7lpfEgaYIqxih2m3uHr6i5R+gTsTQ9YZVbPniA5pyiom9FxIKFLwM5si
NpkYx+3kdZm4durIYi9VtBeOby+MRBKK+Uzsy1Rv8CkyUah8UgppwcCz64leL3meiDV09V4dV1GF
5ARIFANMXs+rPlD3msnfFNCBcC4Fl0mprUA7TQyHM5p/URSsY5gJZ+LJ/bXU4/vR1y9UmJ07mwQw
njxaPE5fc6Q3ie2dmRG/RkTBdqs6buUzICIUn2F+W4rxmUkLvq8MSxZsY+5RMCcQ69BPazFdjLqt
9wR71aikYA40mnIjzOoQVA7HTdNI3EIPdkFKR09NRLTGQLmup7HamUUxrQKpftZ48VwamY0qKuMT
Teu4RXGaqMlxyPPHrtbinWIiLDNlHZ00O2PZdN7AjnIhAJnj5tC0fKePrHKoM852au1rCg/VMztE
e8T0uplmjZBqnMM46WwjBQfMbkEOUAJ+CynKvtpT+ErkG3C3ZMpWQ4CmhS0KNiUKj8uq0ncwRDid
Bk60rbpcWYdOeyP72jXnDqe6L9ubrB2xi6VPOhTN/byY+b+Hh9XaSVXKazM3t7WumN9snzo58rdJ
OX+uB8qJqOeAMWeGjnigReAR4tICC/fUShEQdYTlzJp9VxfpqezDV4uXIvGJ3DeLkuxJy7jxPc0C
E+XbrPU9Mjjc2m2zMcq0XtWJ7Nx21Ld4vwjZGNM1psz8DpJwuIXGcyRr0ebFMQ2bedKfSVs9ZH57
0vwvVs+6Iozkawp7wQXr6OpGT7OyLT286dToUubtUXYo4GpbT45zaF6PPT+Xg0PXb0JKpyzb+u08
e2TA8apFJsKRM/cEkiYzu4tMB/I8ZuwCv+oWtjma3rGdONMLZ9LvTaI/GT1qp3DSgMaEUt9g16tP
XVcoJ7v5olb9k2K0aydA2iLr6s2q8n5h08CI4ywIojbO1uFQOjhvh/yF9yx5j7AKB9w8JGCOn8cZ
HgZBczkIxq/AUT3NHC9oQqPbS1+7ZkSuJTEn4yhYmVkIIakO4nM0hPNJq4S8mwM2d8UwWC3Go9LF
z4Xo9Z0DuDCbEWqWAZm02exNlTqehgkzZhcTP0//m7KlYXLfn7RIPQ4dLxOUeejE6wq4gXmRZeYZ
OIJHxB+Iq7bkNQ39bcOkF4EfswZ7FNLrSr/ZIZ5x0eU3hdew/qvxCj6KN2j1Ftf1ND906ue+EOuI
dyOKduwMevJ1kvmGbEQKSHS8V+bcpOslQ2dlthkKtTR8bFBB7AM8gKzHk8VufqeCYMWVq6RvIc7W
dZbr6sES9XxNO1Nfx0oLnk+tSUMuETFSjvqngScrUvJbK/YvWsUctr2oonNqBTA0mvF+wEzfyhDv
a8De3ynK2iYUb8XI4EmgrgJN0XjFrKBVSeL0zO0fN0ond35n8EGLML+rHTT+3KruCeoQ7L6NmEav
Ti2E4EukNvkNMaghrb6FAkQzDXlLoM37hBi/LSXJK/okz0+Co1oLwP39W+4XF4bGouR49AYAYotu
Aqtjqh6VItimTsAdm2MvEyUNDtNTwK2vYq1YG2o4H8xZopiLUn0DYGHbjb52DEfZeYVWGo9MqikL
7AH/x5DBNAsRZhSzOp8Dv7B30MfKDceplEK7bK5FHyv7iIkBUtk0p3trtry6beNrI1N3oruCs+EV
aE6wsUBgfE542DmAxO483E6B3JkRi7DAE7rtomSPCANjHeLEgAOs9blMWhQh/MnO7A4B0Pgz+l/o
aL3m9VmywkHtqhMdFdrigvqX9d5ddZa+WQCA2KzmdZ0H2RcyVY+xr9D7Gm66FqW57g+8levmPqdq
inAereoa+34mLesw9owtcrum3R9Zr2NqmGg3M9SzjbKNrUqi3eJNRROsPhpT7gUD9hqzoIFQWTwI
5I0eKxqzOm89KPsrSGXooIF1F4Zby3xg/jyLCQFxbyF5o/1Xnse5ro+J2s/0TQY2lZ7uHCmszZkG
6beiJFVD8VHyk5I4WR78leay7VF5piHZ2hP+YFSIZrCb7LZeU6zdWZ2i71olq3aKQgAxPB3qHkND
ZD+GQ7sy68I5N1WPCqGLHZ7rfGGiBTFEHjCE1r018p5GE+S4BeXUvrdiM3OZuGNIyhhPn33oKHgD
ZR94aoUYPJ44OoNnmdZczrmK6b2/KGpVUN3ZKN/gYZBWWg30+OdCfTaK7qRkJhyAPNo7jR4+Ckng
fE9I8rbHXbHpjSreixE6hz9yCeDNty3v5a/8uJXX5/YQryy7D1YgW9VHBaHiGxAWWRI0mYZfsYNF
nCbpiNldR+w6N/IVe7l6ClNLfa6RoW7NvB2eCmscHxJ6z25a6MWmJVP+AIRsjYvLlbRDI/2zAPN4
piUkt3FNodmxEV4iLbvH8O6fSJLPr0NON8BRmwo1E+eEtXSUEleZHj60cYE1OSFU+yKvsuSctm2y
0dCVu/B1IjBlXfnUwYs5DErmb+hONVS1OET0xhdn0EnEe875c1DVV0bE/ICIWfwnslL2IWSfCxZE
t9Ec5gn8YGpxS9lXHiE2yc+imDI8ZjIYHkYnjg9dZmj0mXzjEtt5AaIIMcrBKWbjKBNtvh2BOZ7M
VBupOxaEZzuK4NJKqYfTIjC3bWqTMGrV9uNgjPVbLxtwzQT7bQofBdtQq/Omh8+NHrnjtTjM6yzI
tBswTcVeiLJ5yoWcTuR5Fccimv23WtA6oQeUByDeg3Zh1vlZ/jZYNLKNyNLJC2/uW0VT2W6UYH7r
0G6uAOP5W1ql+rEYH2JsVc/WiCPHbE0YxpnaXTeBQXr9jMsNblW6HZM4ds3GqY+N34y8wiguEFkv
D0+FxC5FJdogUi6o8SrhX0V+P+xUgXxPCzrrux2NCsFKX0tuwGEGcrqjxdCOrtUXELBoX97UnPC9
/2XwINeZvdgRQDyvst7Jj/7c4CMZlzjkIICUrOCHC2uj/itm7o/kGP/ThGBLrICJEOFXaourZ7QA
yis6QKVpuh+lYP/8039JLyznkylMxBUoJcgn/O7l/kt6wT/hSovwiP8lA9NAFfE3M7muf9J1iRqC
MDPcoIth/O/aC118QsKl8Y8wzGqWtP6ItYaE7J30QmG5WKitUKS9l/I4YgLJnyvxrig43/kmAYq5
Ahd0EnP9BXcnyljB1ikVTJ5qEWlboceh508UU5PAjbMvOgFC2rajZ6uvi0OtjsEDGlV5COb0KR6a
L7gnmwvMqcpR5tmdWfejK+myo/VP+e+G2YQ8vGTfs4F+aWGcbtPEOYRsfjehPiraunBGuS0a+1LB
1HBKnTZ5YE0bT3WWM6MiixgtLR/+TFrCF5+YCWRiHO0av/Q3hlAMTmHyVpPPDFprOroTnLQIqw0u
MDcXhAxoTUMUqK4WZyhv067AB4VRGrRikeV8yol/eydpAuLzzv3bMK41ZdVDAqPKNM0vUDupd8A9
eWUFSalQZxhRDNxObVrkiw85jdZ64hdfYfEWu9jkVFawPR1h+uSv0Gb9TT2bwR1dC+vBatHDD+RA
IYJN6oPiaNoup0t9DdpC9xqTsjRNE4ZMGtJYzZp0Olwqf5vw2oUBYUJotnKHgZXNcJ8gToZ+OT0r
lDbBBcTUBIOfgelf+jkz4rJ7bfTFxRGztog3tvHtCLUeDhU381BkvKslrzoQHHkbr4HcxGfaUOV5
Usz8ioN9jtNKqijfk1ZF4A6sQ6+L/Gy0Jkf+WI0vTLvuH6E+lm6h+NaNGYfO5TSmyiknSv1+KjDa
1wVnpTBkspJldJIYh+EyGlFZcIItTigK8jVVS89Ap+WMDrWWqOwiDM9diVy6jXscT6bSrokAxjki
RboybCTdqlrNHMXDeIJiX1PE9mS32KN+n4Gl9hrHnh4w5MUvQViXZxn113YGoDKrC4G8IbIvrRrr
ZhO3PscBfi5dRAiiJzACmZ9cdAYHMysUw+77tvFHG+T/nZ72rsj466PkdrnQPzS3/6+wN1CX/Xuh
2vn57Tl4bl6f63fbpsEf+mvHlOonw9KEifJMhZGva//Abxg68lkLWBXnBI0Zo8W2+Hf8hqZ94t8F
ckSMElq37wHPfxfRCgnWUiLytBgg2SZElz/Rq73fMdGKQs4Uy0cgYVEw6vyQdGejFII3FMJ2Q3G0
n23qZiNofxfL/F5qiSZvQYk4Bh+aZbx85/f7s00ziSIszt1eVsdQre4p9B87OXoMpRhdGZxlf/gV
fiuHXS6I5pYrcr81ZMbWhxcCol5gugEO/RYa8WU4lT5zWwYCf3gVgWaQ76TSSV3efh+UfnESZMNE
sD2ZHyHcCLURWwO/wF9lx1+0mJ98l/fZVXwXFIWOriKndkxLoqt+f/NIQLZTxGQLaXw0XE4sK8Yf
m8SImBU2d2Mcv3YjPZtff7X30uXlosLh6M/3o9AGqbasmx/0xLQ6g3ZolIaZWhXggTJbjpCT4klF
TKdCpQvy6+ux2H8Q4y7XwwFhcCWmvJQRy8Pw4/WsCWqjbVatq+jWk0XEJJ5gGtZoUdrfXOnjiudK
9Jsl2eoawmzV+vDN/Ik9Mo5HnOIyHA/TTJtRlF36H1xFSI1rLQFg2sdE4j4ZYjNivOCGVQgxASa5
r7AYK3o6v75x//JoCVTwPMNUeVRW4uNKR0LQBzNdRTddcNAYJpOtQ5/Stf1I3xAoI741jMv+2uj/
7ZL8ya8lHVugsZUqm5H+4ddSSRGcC3r0biuM3DONfNzUhqFskCg5v1mIH38utLw8YKTcS2wF6Og/
rH7y3MxuqHTdjYcAy0xh64QE+NlvrvJhubP42KFY6yo7oKp+xx39uPzwoamBAw0VKVCZ7FByt5hu
T9ljRk3zm63pJ5cylorXsMgwo1T+sBdK8r/LcSxTV+2mI7oBye/lWAdotMW+SsL0Nz/Vzy4Hzd9k
HfJYmR8f5KoZDLvqNJDdpgm2X7XzHOppWKXHPu0VQPVGisfw12vyw2/G3aROY2FoxA0YOhaI9w+z
njNXQduVYLA0lT1RI7dJJZs//mKCG2hpBjcR6vJHmXWoBVUDSoyLQH3dB2pm7DukIV7oV6iEBwZZ
f/6llo3JRNzNMvn4uxn2st1nQDd53OHyWiXufydQ/oNvRWi6iVCd8YEmKSR+XIhLqT2VhOe4Y1Iw
xMwVyMO1mNyizRoXT67m/fG34g3GUuT3kkvB8f56lqF0Mw8z8H0/w4JnGwRjaOX4mzX/rwuCn4jy
gr+WOsD+cBWHQplppgkjp4zMNczEBY3TFJtff5cPuxLLjrVGqeFQHqHktz5cha57g3qGAA67DhHW
8bdeA6Vk1eq6/5sv9LNLSYuNlyJNY61/vJTQAmserNQdZ+QVYWeMt43mQEoVU/z859+KO7eQ1tCL
qR8f4G7GY1nCzOQ8EdyVnT8e0QV2q5Je1h+vBXzxCyedtwlr72OV5qtgMbsgRFEvA5qqvdlB/IsK
6z/4Quzq2DOocZev9X7JhXphDS0+UdeMleY8K+qsXYiuInRGxVT4G8fST1YexROveV70hsGD9f5i
AyEmNlkOmavSsISbHfVntQjs/a9/o59cxcbRRh4SGy10jQ9PbQb+gvE6otKhLmsPj+pnA4Xeb5b3
Ty9CJ4X6mZUOePv9V0FTFoe+xkWULk+9KK+NywD02vnXX+UnK9s2f7jKh18H1V4S5Rn6wcgfwh1z
H8J32ooULzFYt396Kaj4phC2SnqdSlX2/gvJQRmnqtcTVzKsgrXhIEVOhIwfU7tTfvML/evXIpmR
DQ6FA7414IXvr+UkCyreIGTElrFxTCwrP7X4Rp45RRi/2Rv+9XfC87e8mwTFCdf6cAcHXyg407lU
wb7qyRrJRiIQ7v/65i0L95/uNXYCKktJQ00DnsgZTv+wGvLYGlKSawE7BGXQ/x/qzmtJbqTrrk+E
PxJAwt2Wr2rfbH+D6KaBdwkgE8DTa9X8kuJrkiJjFKEL3U3McIiCS+Q5Z++1rxzoyy8Y+MPhQiN/
QhbsWGX4lyfw12NSfvjUih4bP2rHn24Y4SqVY5oEfpaNez0uhCJv0kNL1hPpKV1l/2UfcXZy/XSS
3nklsulg4mwhRffzXTsnOdno9AAOjhGq3ACDC3aMqIX2OERz+MT4PyrOgTajwuQw9PN2zlvx6vQ0
wQc71P46zkfQhW3tECjlR1DsJYJZEHZ+MWHbR0Gqdk2I6WiVqCh9+fMt+vWZA6zJPvlc9YrIFj/9
eoWcG9803yODdrQmoUwjME+7Jf6wyphR3L8/mk95jS+X9Y5r9vla9aokjgbHwNrkwTDvqsJzHpXs
BrVWYeT9T+v0/7EC+M2jYAspYDlHeE7Zzn4+mhNneQbUt+S2F/1qkimAvlqXBVpAF0zjiq7n35by
81/5+Yn3bIyaJOSyDeOhdz8fEn4tObgFkY99BJpp9JGeiwqxR7pBkHkWEZsvf76ivztHXt/Acdix
CMq4zwccBVJbq+N7CIDDWo2J+xxN2VVXZuQflAh+/ny03zwtXEyaREEoo4Dl8PPR3FK7gaVQKieU
KYgDh759sOauOOYyc/8SRv67Y52/hx7vDxbYn48Vtp7Cmwc4zAuZ1UD2sC4qdPqnsuqX7Z9P6zd3
LWAswNVzQo/d+k8LL6SFxA9jmNNL1LabriuCRyfsBfC3kEwuWefbcp6Tv3zEfr1zhA0HPj0TXsDz
u/f5WhJmOCJvFrwLft9f4TiMt54w9jHKcghfmEF3//Ykw+i8ueBM8XzSZ/98PMuxgOiE7NFGM5l9
SKANtHhE/ZdlytwvJ+v81kICuPnzUX+9iyEPCmZCdBz8g/fTO9jLWTYB5oi1Mku5X7pz+GzRVXi+
GPb9+VAhJ/D53WP9wooh2eM4OG5/uqBElgWlBtS0zp16BAE0y+q2ixT8GyLv6qcSsciXoofMxEgf
sc1flrZfnyE6DTyvgpM9N4h+OlFG+q5EkkLPWqnhqjkTJkkqTSFMLya/xtWZPyCy8/62yf/lQ35O
CCKqkvefmRYrz+e7WuhunpEC8rmLqug4YVG6hLYf/uXS/u4orKESHYjriODnZW3RiBJEl1GgV16L
HxK6VIRK8i9P6C/PCj0vXoTzFYzwJvxjhv+Pft4wTErbHptHpkLp9rwjQyM6cLtSs/zfHIp2CsWi
j+f65w8RqT0QAjzIdk5lfNSaw4TsZYaEQ8bm/s+P5W+uHTsswhJYy1hevPN//4+zquwsBFUEyWlq
rXNoIqsNUNmy+Zft5H86ho5Df4jHn3bXz/sQ4/RjXtULlVFvkGSTKlG++SHIyM2fz+eXB/18l+id
sL1jVWab9fl8EsJXei/xqnWEhRSTQRhri+C5SBG4Y1tHjK1OvxuYdv7lBfvtdWTdwzPvnx3wPy3S
BfLd3Mc2iU4m6k4qtvJ3jL/Av/58er8/TEiZTnUZ8SD+dHqK0ITAx7JNBYLVPGghYK0t+mF/eSz+
6f18Wq64ji4D5YAjMSf55XyIU2kIo8YRAn8snEnPTR4IH8cf4JXHRmAiyeje1Eh+wi4c97jnnb+8
BL871f/4BcFPa0dUTj3CKew3ZrR8vQ5HHz2qXLz7f39F//MwP63Lfp9Nc8/LtdbuNF1VUfjoVo3+
S0/q9+dyXj4Cpv9s/z/fNkfrBcr2ea9FxqLahQJRnlVZfyVy/O7pP6e0ASzk8aex8vk4MN91MXYO
Kt28Y4YsJ/u+J7SIthQ7PlyKQRdf2kSD/fsF+DyXY3wTsNuj2fz5sPPoNZFoOCyx8TWj3CVfnstk
dO/+fKt+twIjB6MyOksepOt8PoyPdJ+WJfu7WHhgIZtZ7uZgOLvfjBvP//qceJmhFUbn5jmV9U9b
V6IUpDYe52S1CM+WJm0z+FoKTe6fT+rXR4PjnDkccH5ooP9SwrutPSKTOAeQhTjHei2TvYfQ/y/7
uV+vHaW7D8GDNdERDNs+X7ugmWTrSOKEcWHgWF+gUuo0gLRvN9Vfzuj8MH9eOthSITE7Dw9pI8qf
rlw5T9ryqSXXqUEhljdWt2/BxNykvt0gAa76vzSo7PNv/3TAgPJd+r7NDu7c4/tp7c09nBmONQLR
IxEjv4GU6TXvJfW/oraK1HBHeLd4BvUQNSQcB6XzFOTzGBzZMwC0//Pt/OU6n3Md6Meg+/HYbf28
aqnaydO2QdsCTMDaZYGo9oJuxh3+p7/tKHlMfjrxkNftH1UQIX+MuH/eNMfdORYuRkaKyMRipZzx
fUbQR6VEwea2Ii+JITHdCF5RgoTHGR2Ey3KjdBoOe8mng6Av+rAPHSjW7D2fe1VvsiqBqdgvjXdd
UmndewwVvRPJTlO/Uq2xEaapAJhnXgz+xdRVaC465frEc+GWTR5B0gb/jEcyg0NJL2z33K2DvRgI
NHR5JFGINWrBrYkmZzTXWUO/755wBznkMKmnOH6qRBkRC5DKCZd6XmTxh4zIl6iAf0RgRVZiCbCX
k1I9uwBWMzto3Y/YmasAObfPJuNuBhgTkHWVWHbZr2xERrTgiH3tq4uGCJxmO6KwySEzlInrXvUZ
6lpSEv0+HbedSyz6ZaXR0pTbKFLVRKAVinsiC8N8GYGQwgOZToEXlvE6J2gccXCYgKxfLQBIPNAD
k85ohfRmykgmW6r82Z3cVGKKzubYv0eLF0VQ5lXt3Ta4WYJdh7EMAws32FkPM+F9W7+V89mgL0kv
2Jgmyru9xFIVXRdLOUfACcBeXMZF1803ZlGl9WgllYNlWQ8ECMNWdCFuAvU6aewrHlHBy1J/RzA4
f8+b0SLFYDSkVsQ+yVQnFrhSXOETydUR6ogZSYZrzuoYQhf8F/A6Nn4YbfxwHSRx8k2yqQrPFFy4
nau8g4V/4ZoJJu6GbmCKFFqm4D8SFmU8MlKqGQCFyzh/5QICyN9424qz4spDQIXkNfRPtteGwa4v
nMl5rSY7y0kzq5X/PqkUkPxKt1kFT3genC7ZFnUPsaRI1STuyaE5M2ws1fs3deGQz1YRzoyz0tTR
D+VEznfVlPBpReBXSHdGIAVsCFuSr01BHt3OblvrJnJp/q3a3mTTgzuq2Ia/JcEqO7P21Hc8++LV
ddMeXIzPbzvbsYk/Wbqs7naqqM2lAAYNXNcxYnlWlu6GVaCyMWdva4JhbVdsXnDtF9mLoxCdrey+
8c75e/GIVpcu4wjpMmmSbSlJ59sGS4GMNBWT+9XWVQV7mJRHwkWYj2HbiybgA7nX5Df9kNtfhdMX
2abR8+LuTWGRXR6j+T56YkSNm5IPgypW9oi2C/CrmAfKtvN2dSuc77g2kHGFiRPo/UIhfoaaLGTa
x6YYXrFPuvIqmUMOPANpgGfJM4unLoGItlVFYz+0RqZ608gmMqeg9ai5VFrATgzjWSDUNnXy1TSU
KVvMvuBCYF0MbwGxosNjxmZ4XKvEMlS80PkVqjy/+9LXmESvgiIhu6QzKdEmGtJn5K2Uhs573TaC
tPDaK7x5VVZhKjba0tg505YwtnUSD2F/yruRcM4ky92HpbCW9HnJEEoTPpGTwVllNaN1TE3ykYU/
fW6jKb5n7XaggfTkJjzC06xZbgjQWQ6GNfOHEnJ49XSlpguaBvkrLc6supjBsiFs7/FabdiDgzQQ
JG58hxtrP6ZAFv0VIyxc1V7iaGtPF70DIzLFjf+mG52JO2Kb7f65amdxL5Q13NiLTfPIWJFcLliH
6hu9eGMJa7eNmoMXQ2RZ0wvqvrSDLkos8Fb4Q89x1BzPQKduj1XTIY8wBT9tpcJL9i2hMhYWXJ18
d41tQ9vEHWyOVdQRF4LrBGlbyo4x3NlZl+eXkJ8j+ySN8J79VPRYq0fpvADI72bsjWFqdbzsU5id
5kSEF/YMOuSyHdMajIDXgOMKTeI2a8INoJkCiUh9Egua3r0leRx3etH1aLlJypThtiLFc/yImed3
V33VBFii4S25W9aSAHkizmVkzVa+3BFsoswbQj3xFuJPLB5ROxX2RdljyTrMEh8JaUOeC11utPH+
AcGzij1riXZ2Vdi3pGDNMW7oTWJls7fu3alKXtCHFx+t7pxnv2xChKC2VaGDcOHsrETGN0Btp9Fo
jCeLm3T3MZr86qEsXBU9Q/LNkn1Q8rqupoZSBGqN69y7ziIkGaKxzC9suFUdQaoKRakQpOhscFio
FF9WAfK6hlld3yQEPJTPfl26zr6IyrO9J0Ex9pgOLT1e07Z8JQsc5hX4DQBgPIg5UaBRSojKasCb
IkDV8JS/WiTT+zil9XiSVjIB4li4edsozESPDFcV8SqKCO071FABmh+Kcf9MzaSrd5MGwfcuQof5
dSrwKfHXoiXYZhZW0VW7WB2bBOjQ3hPLxjmyZ4xLAX6mb6AkNJWbTERzUvBBkRpy4tXHacAQ6SSl
ip+dzu+yL2SLCJuHPfTnDXjtUEGFKhJ9X9iyTb9UpLTJo40zh0e6CkdZbUPYvNUDsYBnM0ZPFAlP
yZJnzZVKjSlOfaui8pAkQHTXegklVF4yNTr1XFtDTt5QRApnpFfF4tr6bYgY6797Q9In94hMq/6r
O4UTr1AWp951VyXhd9nE5KEaEQ0E1KPbQMaf22ARZl+fPUkNyzKC56EokAz4IVcY9+qUdU/sjEjH
gm1Mttphwmsgse/Nwr5RFb3EZ38s+uTLxJUe97PuTHmj5NLZO+aLqd7nyewCYnbH8tn4jpzvZ+1i
XuT08+6DcetA3HQxyxE6stOJI7CbBfNuPQYTXaXAPXk9yesvgGnoyTmQyxTK3nC5ADZjwgMJjDTP
JzuqcWX02iYIsSiFPqhZg7W3w8xub/pZQbo2reGer3s58GLiGMNA+VZVhWX2dtoRQmvhpvIupZOZ
YEddWdpXePdrSNTDVOHL1iJ3duhQyHolH8uZbpPeKpwn7btErqqxCS4189zhaxsRrXEtk7mh2xIU
0u6/oI3lYap64wy7AaeQfUsmYQ6gYJDRuzUI0T8FsQFmLf02QrM7jdjNtnye6IhaVk5KIK53f4ZI
MBhUye9tMhuiaJoEnyocvfnxn337/wPh7f93/oVzD+xP+tvy3WSftLfn/+G/tbeu919wV+nKn5vH
CADOVfB/uxXwHZz7XAhtQF38t+/gf2tvIxi1tPFRqaB8ZLN1Hm39L+2tHfwX8hJGelRrSAjPoqN/
wYqkFfq54PKQXKEFozxnBEPS3tn/8LmBGfOZX5wFB/AUBjmMraZbLntHkOSA3v4prYWB7SFgtkNf
U7uphDqTUoTeZhGpTXXokA3sqPIB7lkIpcpSpDSJZVMnrX3ZRzYxMj5IqWTpqX8km7xTMpXNkXUb
73tEfo/p8NQZtgoVmSVkSJC1umZAeT9gucUSiey90eHGNzziYmqf5ADFMA2xbzudPJUcvR1t0jAJ
tlOTt5nbGjBiBGM/KUlJtoqWsJBZ45ok3su3rR+WEz2PTbFLlnHb8609znbPy2Mg9LeAQibLb08t
X9xVyoIKAgIuiu7DDT7X+KHr3ufZJXcDYskIUQUwmc/xO/tLUhW7yG2uQcLJHTPBB5a7fdLWm3Ra
cO53BxbeTUTOGcEoxXokkXyrCQrHH5zewBoHnY6DPnUIss78K2lBBra2PXxGWZXRjV1mzynD/M6d
iE7IyD+Xm8Rv33i7ByT9sBZy1/ku+j59ZUIJbmPwCFTzbGtTtTYkcnJbj1lCFs8UR+spIgbBJNVh
rgoXPFha3NcK02oDpBof6kURhdbWGnuiaTqJMHoUX13IF5vB+5a2/ikV1l1bPUDg2HjVjmbZVTSQ
s1Ua8648eLxIypP70FbXXdGf2oEUuFM8n/G6PXNZhmW4pE1zNIP9whPFLjnUF0Cs7munvmwNPShX
O2TOjP7tUs/fVRDl+OLqY6QnffCaiUiE+VAMRUdAdHEyY7qQm1B9y7LxayK9G2hgF4rNA214vHx5
ZhFUN5sfHs/WOpf1kfkMISzQW3qxuLtGjvlhKsuNFXg5ieETGXKa6QUkAJXfgEcCDZTokjyE5dKp
A7mvjcl2dMrulQ8UjyZgmbN9ieOsOIi2v6YOGvHAdl/j0f6K43MzzvPRxWdCdFwNS52JGGZ/haOE
IRapqbdjUXzvM+/OVssPx5D/HADmwoIL/l65u8ghemWhXvVaSAB1nz2Gcngs8v46acUXopl3UUU9
x6AdmpHDJgRrxjaI02OzdPgZ649+zKAtkhLxrqX6kFq/ECFYFOsp5wtMPAohtQ9R425cKlLbKr2V
Tbh7Hg/fkgHpKSF7rvC/ZGqqbztqg5XrMohaidEGjOx8LVLXOaWWCjc1bkN6ia2Pqbo8dQUOIQNJ
CVSeGin6ZgCwHdaR2yW58AhQC/p+A+ViNduHmGwa4sG++bN3cmK24ONp1LvFnlZ68pINtXbIy09S
AjAZv6qOtdozn15XQBYbFe/mSb3Z576lCSEuVLwLptSQUgSpls9u/6WZcPhX9irHv+tk/HZe+XXR
vRvwPmW5DtpnHfrfUrIrQYroQPCH6PO0HYpvYDERH+f2zQzmrKlTdWPZBBpQwgL0UXnCrhXPDeM/
NinzfQiUcz5pteAkcN058756uZaACyWrTn4Op81CeYziSaRvIq//GT/MQVHfCb+X9U1gE8Dx2lCr
E5WWSfiHkepsWKt9ULXBIZ6dmcSRwY2BFZQEs63YE4AvFEI6mK51mvKjhsT9UG0V3ogICsPGtix9
R5oOmwC09UQL5w2poO5SaQ/DD3XzKhxI8dynnXSfiawkFcvMolV74o/8r4lIzoSaGhbLts/J0rnw
8qUjEMBXgDEI9gDNweyi7EBPJW6uNz2dZZA0cFry3cL3xtv0zgiXE5wAUI16cMGgS7dsbhdEFUAW
VLhPYYy8Vn22imecamMIZsXGWo/LSmMzVv2x5C335qF4oa4p33sUeqR93qCBta6avnYfmthN1tQA
OamLAP5dnOsrLIDDa0MM/ebcB3Mj9KSZGb9FUrYHiIzVjT1oXh1KBuW18H2nQ+1gEKvS6NQtu9mA
Np2Ki8EzVzT3QGIk64q8QB8My6j7g87zbVJoLnxza7DG6SjaFy73HQ2z1RIYyUo7H5LlZJt6WMdn
AJ9VXeFuzikQhgcgoCST6Pi1h2cbxVCWjOZfEKy6yJJ0ljOc008PFZwVAxWnc7xwM+UQctgQ7kYI
ht0ZAlRaZtjiOotPwOKYNJq9O2rvLUBxtXImvMIT+8ndwlt09JPxyU+bNUA7wqazU7+0GwOmZTVp
XkmnS+/9LL4KwYYtugR5DI2hRdnzkMxpdTnNE8hKAcAqme7KxqqOsiwvKlUMK4I247XvxXqlDeau
ngSmZmyRg/bfyXAhIAWFA0qs7JDqud0AVy8PbjIjmgkCeAceBNp23rYT795iym0Yp9WtqeYdbZsf
inBszD+UEz2RR+I6TF9dOfc7Qt8uqr69HaBd0VNaE8q7AtS6H5MbgsX1VofRU2pNl2273FOpkvZE
3b9RquKjw+wLvM0eBeshEOqHmIfbAETfDTZFIsAk2H1bhVt7si61N0ISpY+qigiK20jUzEMkp/fY
3MTFOcopt6K9qexdCuktWi6VX23GWm/QcEHprEP9rfGGJ/g3EEuwkxyHyU63VsUGPp3cc/ptvW3n
7hH07mlJ8YfHVnXwiSy69N15Rx1zO5zBB+BDNV3H6rbCnrnXMn9Y0vdaD9sqwyG/GAhExsbqAx2y
bU/xlL9Wi1jPAKstotWhTo0ASob8ImyIeAq4Am2Q3cNWZD3e+wHr8iQqyuQmWWegli/IqPoRAIks
pfVRquYQNjxIrb0FFLthRLTGMcJQFrLscZzHYl9k81PrdLsZqGEi7EMSVK9JrK7aJj10gLQS6Lyz
VX/Pob+Yqtqi2cBPyFGzpniGOXbwiS8c4vqmKEl3VCIJd6E31UfXm/Zu1xxAjuxMGn0MBRDW7LaP
L1PG0C0QPGuG2BWyGEcPsOUuyUtif/OoZbyNBYZ189y5/YGeYvk0toKv4E20iGhfDXgaYuKKHAuA
cbQGnkRjyH8W3buurK8RoNozRikmnDMDMOoUzlr28cqbhk0Jjwcmy2NlI95J8sDZ10VYPbUmeraN
KL/wTtLrCfjKNcgfG0/sk9L/4efuVgxsabrIsPpmVI2uM60JJrnP0r6baQClDXmOzxayYPJx7G04
m3rvNTJmD11vEsVSGM7UmrQkeuu6yuHrRW9g9Zzios/uqowqT0Pv6zNSyHDXJ7embZ69MLseiZvZ
eIOEq1kHqyR1BBLa8UIPfDJE884E64IovOuoYJDfZS3piDlMGTx+pAqgYkoJCewYSqt+VyEgfjGZ
rvnSvrVl1ADLtZNtRCjrGOzpFWRrLa7lQKMzYCRxANYbP+YmJnP20NbTy1L5d6WN08hq5GvUfcCP
3oxOetDNPGznOLhj8G42gjhdN+npdEmsogN6/F3uxwH4G7POPKiQOc/P7ADY8K+RDuyTaOk3uGU7
9kSVemzqugxWwpfL1zZsiJvjpdOX7qTzzdhNyy4cHLOxHau46mtTbrpWPijFJ8ZumR3QNntd4Fb9
ALu2yUbaWbabXuU8Q1s13kaDeVxIYYYedwqW7giZEpKcg5DRxqDTAYKak0sXfbVu/R19/43XEXwp
S8xjVWDdAUscoOal+gky90N17vlb8wXQyH5bx0TxNLTT48x+tmL/QgXxAf7LERAVREQLuHMQXYZT
epkDJkkjxEV1+DxW01dira/T+i4avY+Y+B0+Li/dZG/SKtzG47jNScvbmlj5D55dW4fFp8PRSzqi
iTr4Q3Nh58uVkyc2q7/hPGJcumO91Z74wmj1huDG3YShGdAbdQKFKybmTsFEJKevp75bQ6UmLTa4
bUNrn0pJDuVAHHnjH6ge0nUPBbiDQ4IHfN3KhlS8lovXe6BjE7BUB+KSHl0BlaOpQrnCRPIQ8ZFN
q2KvnPjomvGRjeBpbKpmFwMlXjGbOUENYk8AQXSM1iL1nBtM2JjHrZNh/Yrr6iMCcLsdy3gP53M7
eHd8Vh48/iclR7NFO0IilQJ0ZHl6ZXQ8ntppfC5ca+1n4/XS2jkxovYPo7LvySR2Y5I/jdF4Oab0
T4jWepH9dEXcO+92dJi5LX58GCCVts0bbM5MURNItrdA0vi+iu3AHBDAh493payfO1i+T4xIByKv
wwPxHdO6K0e6p+JmyfgiZ0E3Qy2nJkxc8+y37ltdSnsTRNk1sdDv3ZJtVV09pt00r/MqIuTZ/jYO
0bp0u+DU65sOO04cqEOnOrEWFvT8Vt6GQaq+MFPa5Qro4+KwO22D9q7swp1Zgm7lZuZHsqAIHGOn
YYlA785cqFuJiBUrGvW2m5x3ERc0amf3Wwy0CtBLSpLyBAijmOqdQhzvxsMOcJsm5o7iww10dYGt
ll2ifJdBzToSkSGYePMX4AEfiWoeKO9tWdHUYqQbR7thHHeEhxebHhiwbJJ7cCg7L3buTQ6BHhCU
Z/JtM7rf6l4dQjN98eP2BcbqugSeO/bUSDWomvAiKuVODeUjSZx1X90FkUf32QvI7aWLJ4fzFmfV
EmaGKjEzz+MYB1eq60iLWvz8rShCtZV2PDUEhndEcGrow6TRB1H6NUkzUIdOBlAmccflKpc5Wbqi
qe0jT5TVbIns5gazIVnB93SPqY7B/2Wh89DbTnsr7EVcIvQfCO+EjFCKbCQ7F5sikmJxBPY0b9RM
8RwvyxV0mG4j28BfMxNoYCoRj45rs1xnTmJv/MD0+2UZQRK0Ymci8RFLgjhWQiT2sajsaA3QEW5n
APlE6fiNZLD60baURUGXOB/lVHbPPeCLPe11vYuSINvXcUvapAz7o4Q/fEsJa9/FrmUOhNxCquo0
CRwNOQ67NA3dR5fppwGgJkAuWsns3HtLnHscv6HMsWg0PcR8ymhuo4Jg1CbRQhLHuxlLDTM/ZuDE
R8OHNM6npej2Qb6UG3Nuc/TFMDJ/Su2b2o/NqarDrCK0p5i/+Shc1yAjpiMrUHNM+nQ+aqbQp2Wo
qT0GCUVWJTQMMmc3i2jcijSYnotoqY4eI9CXvg2mZLUwlt+M/Mx7f5rMj5j9FAm4XrCvXdjlAiX1
zRRX87fCiyh6RYViv6nJzevrJIyISaAKajiz5hLwW7q1G+JFhjQBA6OScG/xPLwnY+/vI28uPljI
T7SO0223aNCEIkRpyJdq+i69sH0ZtCZlzCl898H4MHamsZYwpyfRAreW8UETDnAQnXQ2FaV6n4PJ
6L2zGwUIL/VvR4+f7yFZK0zYdyMX/6qqkTGLBMLHaI+EBOpAe2TP0ipsWUp89wtNmLhYF4t37TtD
8DE5Vf4gqoLrhfQz30eitXatI+IHbVLYPHnrXlZonjaVLS4KK4ORD7Gq3hL5zF9jRDPcBbIVbwnp
HK9p4AjW1GFY7gKGYNkqNFX5AW+ZzcbUg5N32N0egm7wIY3NcAfldA4M8TLvWy1KPUOBdA1xzPFQ
HDsvUxeq6IuTZzX5Zc726GUozHzMR9e7IBM8UasgjnyLpGYnPrkcdbWEJMHsykZ5bNfh8z9TPzWM
F/jIxCI4ZuRyDPFy9CL/zmbUywApup8AqBMBugfpfjKFSvapTX6ojxBrYMPBQPw4xJiTYY2MdACa
oAmJ1Ku8+aLNSEddxZqv/woBQr4Qtx3tw8zoDYW8fvAt45wBgujkA+p6CBtD4FF71ESGD5ZYI0Fo
95IGLrA5n1ypxtTpXnBVZm8mGIV3AL7nkJxBdiPFTmKseG9xnJ0KW3tDJhTKizAwBAA2z1pH9q1F
Wgr7gPqidM0VWlPiHQqwUUUU5Xf2sgRXlgzuG0mmTIiCY+r1fnCXYTw0XUdgnzJjcDUFQ1dtVNmT
NV23bwXxArypJh2OVZb3cu0i6wxWVquyiw7gALnyBUsqMzfw7pP88OIBHLFN8/Uq8Ripr+ay8i/Z
IdvberbotlauU8PW1EN3sltS/MYG+IcP965YuzBPvpXOQs9zCfyEO4ogZj0CKDWCrTZRAehTqL/0
a9pWQJaXsVxY/UBDrAg97+INggzIA12tHq2+a2FI8vee4kTlDOKC8nIJpD7kTnIccGUy5xTjlXHa
cMuIy3lw5XLeeiyhPhppl/QUg3g+IRlhxJcXbX8FWLnfjbb0Lp02diDHazvauYYKkXdrsWmqDMOR
psw2qygD61FsdTIyWQz0+GETdrCBMkXYgO+f02WabeTrnZW6+7Ezl2B9zL0zVFT3oyumr0HZwGJn
RGpRMBfeQn0dwiTnI36kvOq+e1mf7hYQ0SW/IlFrIpTSq6lKpwsENrRLHAIZuvWZ6HXy5+bWC72W
zU+VqLsycp23hBosWnUjyiZqSMnblqMxsVmx80LpGydInuTYPRYN6GuGfne2Joy5tiAkdguE4YaC
nnaH5PJC9G5sxdPtfhmc/aJi8xqh87ksXTptZVCeHNZaSpvszbUBhJtSvfpVfmtPw4OO7R8sI2vD
pWRbSh1uXWsVtGwsGro10mw60b+Ec8AfmeOXIbbLrV+GgIeJst3WTbgRjb+2JCIOtmxemZAGjuH+
sgugnMkvdJLsfawIfotK99ZMpCEI0+zh9637gmTazHhPPemfm2SRwx19plsmcruM3mouHtzFDi4h
tH1MrH92qej3Wp7sLhnsdXeWRTO995hqLjM3cjWwOdG8SaGFXyugX5fCG02d2HmL5yYFpw4e0Cw6
eMyUvz0D74pRPBAJK1dTGN5MPTsHL6q+ltK5JsqGaNa4HsGOnwOzcyJQwaN99XhWWlblDZPOG1Fo
9CddvA0r0rUD86X05bA/2/XvNfkbmFWmy65wnuvF/doP/vuQP/YxEMS4IRxAu/syeG5KJhDIwOg5
DRWutQLGMNQmtCpcxCx4ZIx7NU+VWUGJ5Fur13QRyQwQNs2UvF+1g9mAlIPA2Nxqunz4xQjSarec
6s5jRYiZvlSQiqibn6YZLG5QQVeNu/xEri6xDDnBFrmU91BNY9qm6sGMI+g8eIMU0JcGvU0mqBey
0hHbbC6/pz2j5XAI7rXo8gNj/+CSfsOhIYCJSSqbvDB0d65Vx7cEqOUrwue/o5Ujrbtpagwt4T0c
AwiM6M14RLwvmAZPc0tzu8uCaDsImyrZAOBt5cvYaKqC9qn00x11UbcZwuq7yXKzL9MW/B7xY+KG
Qa31iDyxPpoo9qu961uvdA4uxppeNRTFp9AZgd1O00Ho/q6bm2/tOBIZFhu2aE31o09y2lvix1Tb
zzAP8k3jYhSUkmARUs6zvQrTYkdH5RFaO830pLtLBOof2s/LlUU2xq4yCQBc0r7WgR+Mm653LxsC
2kj9OUYJlBy+KwQ2V80D3XiLEBUyo/1s2KtJynU/9wyPGGYcPeTYjey7YOXEXnPVgGXcRJD4FxKn
hBuLjbA7rhx5ttpJV1xnj17O9DJ7BagtHV0W4+JcWeRAr4jNNnfTCMt6EFSxKcm989JIcrfSmZHz
UHCGS8g3F3lLV97FbRZup8R5CIjHWoHOd95GLwWzZ4R/7db/g73zWJIbybbtr5T1HPXgUA4M7iQC
oTIyUktOYClIaO1Q/vV3Bdmvb5HVVmU97xqUIpkhALj7OWfvveI4RWWxZNf4rrPViIkQljGU4Fl9
+l3vHrSR9/cL3NZXNvL5WNfJuzai9NXRsX8V9dEe5w9yesOjPGnP45EsXsdNe0FVFLV5tEkjP0XY
UpwpBTbPhN8vl9gz4TXZVugU9WVE5Pygm43wg7e5pWFH28OgJcVgLLCXk3LFCvvUV4t1uS3yl4Q5
DDFj7nqc8z3j+/OKFiH5rE3gDYN7sjye0wYEc+/knwhXtxXqH8ExbwULc1vY+WPbKe9AnMHaETSq
RW5vJsPgIhHGalDHRfZjapBHDxIY4kugvmV9+6LzILkMJGmwsRQEarGpcMJY2QQJ7CzEkcrJLio0
D71w6WqzRCdUuKnQ4xdiIrvNGCHcQ8/2qCf7Y5Tp0SANknDPfVYQzJJzrsIu6dX9Hnnxys2j9jLF
O3Y1mQJTIbHEq8ZiqQ7MSIeMNJYV9rl6baYBi1rGh6R3VTeX7aAPVu8XnFoJuRXBZYXyb09yc36R
RwYpmo3jrr0mf4By92zY8zemWHxcfe1ZFYYL53xCSF4CGkzDUMyhXXYc9SeTvP30ce6gJTVVcnBa
RCZzdIwqcXI7D3g5xHemfsfUmS7YGHt6wCIzz3PNrXLtJiSKhuMF040st+k4msGxEOiaLO0+95qI
dgA5YEdmV1wwDnkwAkwLA7jN1mhf4Qw44Yi28ZTzSba11xDfXnrZync5t9lPdfbaT9/anmGHwa0P
RxBNh07dryr2vnQEaHfSOct9BAOsioYvwunH2rVLEF08sFZ8ZY/6oU7Tt9rsXs2ZsUIZNZuB2Cny
mNux4LK23rLSReJA8fD9MKDCDMjIs+zBWEUczzg2xGKDJmrl9uJ2bDMQQnwPWYr6MB6gqkeEQJlH
FZNG3ChWB+3TashrkwLCACNXmSBjtpPXrvtM7wMyVFc98sB1YkYqpOy/KmcA1IUrmHSl88WM422X
lI7/KHP6y0C+ASrksr9GSf0xMO0YicQ9jzhHg+wuzyKzuCVRL+wb/cXN6ltEclM+b0rc0KEuyMof
ivqh5Vu41LlgARfeg8h5fwu5yYnGx50LxTjtqea+c0fzm2d+ZGM3vSvmh1sXpJKR35geHqu+jgJI
Cv4t5Lo1os/r7LsutSmfciuyQZFpTtzjPZJLa6+RvwTB8IbCbMlWRTDBa6Cp1/o0qZV3a1rxXiu5
4rft6Kky1AAsMQds7TPruCnuTC9dI9AgirrLHlsdQ0Ka7G+QRtA+Wgho2zNHLYlRqGZbzPBMFq34
VpcMG+dZXLSxvos4ghC5zNyZEUlcfgMqRHBiQ1gxSqSdi0liz1Zz3bLIy6ba2b4btgM5wMEMEjOL
jvFUQoUgupQo4QFvXrlHNX0IGvZqErCLDzaUeD0GTrOtjH5Xp3TX+7ruQgSU9GcY45kErV7zaOXQ
1vUdtdDa8xjKAdhwQoJY65AEwXFlyemBDjDtrqHZo/xaCfHJwX9fJsapaqjtM1l8oso+eUX3DO2N
R88OSGy7YSK0HrmTc8GCjIIxjJf2suJQWD4XyKGJLXbpFdFT84b0qYQmZ+slDlMlwILnzcdkF3c9
sb6+6ZkHxwMiMkPYaxAMiPgll0zwG9F8K2vkCIsR7xRbyFqY6XlUttD0d2NSL8f0VAKSAmBXE0LQ
RSiFnaMZD0NYwDoyxmQTVNPyxTPL7jnV5ANPBs0/SVMo5My4V4vxOhM6UyUkEDvuFKIDmdZdBvxR
5hdO+VmcA8ErdJoLYPhxfkjOqbPmdF8LRL2W+kavk3mmGfFgRcvj5Gfpl2GsbhaK1amjQd2Mm3w0
KIf89ugrdSTr66bSr7Gp141PGmiDzLmQt7Ttdijdd0MEVh1ljMW9GNndbhY072q5sDr3/hZo36Eg
h3xnL31YjumVGnEEjCP/4aurvmFrJkAPucI144FDkwkAP/aH0bLuxzhXq9G8JBCepGrs5P3taPWc
M5F0VPFwbVdtONpP5QBcgMFf4NxXsr5Qi0mK6Pko4EwRJi+PChDwTsWO6BsvBgYG1OnjsZeghPJl
J+yZk1J/mdXRll029MehPwjLWhvj3vThruI8ilJ/p6AWEPC5UjWGhLpm2NJyFDVXRSwfenr5eR2R
Ce640ADY0oP8zurb52QhTi+Pwfn4ICCTFiaAgGQTs8qe5bSzlx+o8UFIeOCdkTTBGTl03nLqRcqT
ZU2rNo+fTTBCuaC1Ut5y3Jy2GVPiGfEvuLM390wOdYwHBdsEbNymQdRuaOoGm9qiE4wNrOPQOYfG
0wo2vU0Xt1S02d1taXVlWPdmsnbHdF9plAAz0JJe70TUX0BSWyOuXUVF+eYWzvMol2t6bkU409v3
quPYtfsqYPNy2+TWgE2F2tgkHl6aC336rFm+WhGlU7Q432aCMwvNF+U2d2aQ32v3IqhUuBTWfVqN
VxNDExb2joqq6TdzkKpNlufIIuodo0bctqNBHe1zZxM9G0B0zK/sotWPPcdTFsiEhivtFCd2Llzy
zf0B2qQW+qPn4JR2OXgwfe/3YB4Hnzl5GZwy7beXrTlkV0iS9DXOneNsaY460ecfVHU3P+xIv1VD
eVOnler/5x+/uJS+C9XAfZ/7pBjASQj6RajWBKOO8opbg2g+93pB3IivoxryzwqE2HM7Eya9TgFm
Xs5jQ0Y4wgxlgaJi1Lv5m3dydgH+eINnOD1qvrPyjoBh/NgY+7Hj/iyZS1GWeiVsyBXyvf4NTg1X
WtATJMW1rPK7tjSMT9r2/kMx1P29r+xpy+CyV6Ghvfzr9zfzX93lP5AY/uG6hG/q7bevlUrVcvVW
fv2ff9zV5Vv1C6H7/Cd+CC+t4HdpkXtCzwOTrxASr+MP4aVl/n7mxnu+7xO3R5IRhsJ/hp46Pr+E
aVFyUYF6o838l+6SqFRP+DRwzwZsLL04Q/8D2SXmzp9uIYlREXz4OcUGS7d5zmv6+RbyayNXoBfI
hYli3R6lTgECNg2honuPLoS+GXG+sHXKXsflnaHdALwhWFW6ak1S9k630agYxWc5151gQzN1c1A0
c5gK1IKxexCnnOrIK0yikCaHwbbg9y5Fz0K629orYtFeS20n4nIxZ23sVVYSTYzgrYuThxzRPiqb
ciDxGNpQUdeXbu7QjKpSKZDBNLGH+qWuhTy0yJPv/WGSx5yUvBt7SHt9SIfcea47RST+XDbwhRdO
MdcS84cfDrGcGX61Fb7Jd1dpQE6ko1VTdAk2s5vMMLHFbD7SKS2iqxZlFV1UZP8VGLuA0henIkGT
ILDRGAW0XV8dsDne1irGETEPWYDBSgE2iDZMYBu11oNNiarnttOrzNCQn+CNocD0DR+QROlNsbGN
Y1k3YdX3U0xYfxCcSqwP9w00z3HbEV54aRYTa2+O9H1Y8RHSL3TA1d3iTUBglrSHCmmMFdSJLvMQ
4k8kqGxx96UQhAtf0JsCjDecz3tiLE6OVU8vTeY1HvO4TqabIu4o6eCJICjiyOJ8xSawPEH9OBNJ
F7q1QIJ52Zh5+tzVl9orpUMPnhbquk1F/FmVmM92RmTclYXpAj8lMeYtItxnHdQxKhWegstEOfr5
DOyVbbuWLgaKC6ukz0lzMFHHjIYqrFs0vI+JnY9Ic/0CVhxwu3UkLPuCcmZ4jzm2hUE6F+uxtIsP
061EvGpLzBJrdP94JnMX3V60YIMKAVe7RzObsy8F4xrkS9lMFnhTagDaHTaHb3E6IJgxsWEgQ+qM
Itm5hhz60GYgf1+ONQyeLhgBwAYOR8M2tyu+G+5TktrmEXOgTmBXog0dAiQ5rim2A0lVBQL/HIAY
4oRlo9smgZeOQKFdVyJX+84dYCkhF1Z3M7XRsCK3oX4eCPc+0+hz/ejQwBzXUypSFHLOiLVjRrZ5
VafG+a0C0EZPkIzdQ9Wm6advpa5ChJSNz1OScg5Rjb08sAOcE8C7CN/a1LbK2C8peyQR6l38GQRJ
8tgJqtPQimYGsNGc0B+ap6WhqoSmB16hy24rI7DVKm5647at3ExustmJJOcIr4ArtozF6zSO1O9B
VnMBMMaKY6mynqY0tp1PzghquVRJTqxAkNrMQTCSPBJs5RDZ7mXRjkkSLqxYRfaLtWCoXJl+bIwb
us/ZdVEYDG4I6HC/cepn/mIM/BpYX8n21sD0viQWyH5Ii6y+6wYJm9GRvXVgS8YY645O/2wQiqzA
7wwLQg/CWOGRR8EpLbETYw1sszk0ywE2pdPmY752Ss+8Jqye4h1XSk4NsqBru0DWjW9VDkb/2UzG
9LWGN1YcwPUF8Y3bMDPlPGIu0SZQrGHvnIL7fg3kLHpFr8mxKBp1XLHMGZ1YJ6ASP3CXOmTDigbS
IbMK+ajmsZRrC0kvPu6x7qC/jSJ/FJ6xRKEqBxCIgT0KlMWZ/9FVS3XjT4WgenTbGOwJAcL1thyS
qFobojUYjTE8WC2kSD9IhRiTXrRvFhAMreSbJeeq3eRlU794caz6C+WPCu6zPUfn+PbZpwfM7Gbd
eICnNv0Smf6W6VmCf7i3WxL4M/rjK8+bCVWwDM6HcbGU/RZaZnl1flaDLa0fa48GzAIDLubsBo8m
h1I7LaLbqDDwVTmc6m9a1cYvDAQpo87pmPGeF2Uev6C7iQ49Tfxljf4IKtVoB2gpWsuuk9Bpo+Kt
NCeOvt3EqoaAptQOLC4/K7Zymjiwe2bj0rwhBvXW0yJDKo9hrwM147IRORnea8Q2hXGBJIRATx5j
/SGj2H+srUF91aUP1ltCkSNOK86/9GhmUSLXHtBlvnDeuzfBNmYyH+f3OAl8hvSWA4BNBwLshk1n
+x5PoZvtJtfIC0aOsoIEYpZZgkR1TF2AXFVUbu3aL+mGJ0H1xFXDXUBvO/r0xwwlYuEyZFl3YBcF
gmCnfqyZMMFT8dlq8IHBU1PUc8mu6XNMs7ry53NrvqvWTYb1aJkYUxObv4x3Ougn9FT0afRq6cb4
uTDRJko8RFCQyhJQWpnCXlibM8I0B3swJZQdI8SpxKQ/izieLlKZGdgOlx4mi5gX/K2LLtV5JgHC
iR1VvrTVbL/iCIUt6qqA4imZ/I4IAh0wGSwWcUeQCUMZkLPcrnJEOzyJitZ7k7l2G5oWXJNtYnhF
u54CA6yaWdnmmykdUvN6rKfDyq9K74YjNFuMHlqnv1ziorEJWHKWGyPn7aB/ogMe1rHVPxHhb91q
/gc2/UUxB13sVDyyMdUMdceBQDu3A2uUficOBxjsmhW2kcGkrK6bZlvHxAChDhXo5zDByBfGc0CO
G88xrgg70qDsSp+7poQ5v4Sy9DBwfmcsJy2YLbTMg0KmZ/TDBz8jKjaIyazX2EnSm2YwU3tTTI3F
85VocVHOedISYpOAIY18N70PtEoibnmEyBuHI0IXWt+h1RFTcrznAezCZCl43gZh5u/anbMrxDF0
EsHCO4r9gasYNlmlbgXsjOWizAWOtQITLBgZj8FU7S/0tmV0bpf66MbwE8dR/oJcHVu7Idz2skBN
SSUstUrXpWKYvFqIGH52CY3Bmpf29mOdB0LvbEn3Egm1oYctpviuALPcJw5A5HSiA9/wSpAOs1qt
BoBUel9XjSTXlIemD3GXug9eqlF0AuKNmD9lSXCTBXY6bmQzpM7lbCHv3aCHtOBJdwaywwliNMpS
PVrvg8EYgxNE5L/h3oi/YJwV7QUj4V6ymxdMzXNmXneFqDuA59+B9ZlaEKmKPCPcyWrH4TbBIxBf
aEoieSidwRsvO+2fH6VFNGHDZpBdisVx6ICnSNHWtX/OquyXUdxNWG3uPBwLXyZZMq236j6jXzYA
vkTnXvSoV2vu1nLOqoVwRhf68pagJqRcZp1PxhUbadIe2xJW8rYYSoUkJ6CxYD46S+zhz0Q41har
XlHmHXlKh+oJoXs3bbKsMJGr4xmx9JNJgIHxPptK5ycnq0R3j24hT7ZlrxxMGBPL16WLB8G5s5fI
JoAA65P1N0l5PwecUCqQJ3y+Ai6ljBCku/5cKiBwZ34FxS8E6ASVqsO5HtSy/PhD8fT35fX3l/ER
ipwzuliXPeuX8jromqrnzJfT/poZwMODnO9RSbBIcnJEg0onvbn0mppOBrkRwbXZTW0YybR7+G9B
q5Zz40C4+Pj+0kj4i42Q3/6jmnWoSz15DoZ33HPcs0U5+aOaNYT1O5k3FoEpLjmKQIy4bv8sZ8F0
mPwFocNzXNck8epf5awwfydc2SdD3IeywM91/5Ny1v81SAVnK+8sCOCE8E9q6l/ymXxhqBg77xbR
pOnuuUf6KixmM1Uv9sQ76wAr4spAPhFoHzrMLCba+XHbHoPAGIKd67XNeEdepyVPZaZkdjCJJhi/
JS1P/ZFZ2rgJSlasQw/FsAeWPdjVNm49eCGOHzfJCtVdEnGYKqrhSeYUNOsZnJ7Yt7qrRchELgle
UMrVCDpALlXTvd8KN/9EYAhbYmXPMvFCsyrL/jNL8vS6tPsOyGZdTOnn3FtnR4DXdcEB3N3kXGOw
QSCQ5KLCyZc58jZN9MzIoNJIS5DEiejBlMDUz7aIOUwX2olT8EHiw4n5UhlCur6NHOOys1NCwSFU
Zg1DJgeaXkmuisURTammP6Fo9p9Yib4MQSMALDuRbZKgj/5Em/LRSZNnklUDltagx1bgzpqvlGZc
Sf94YE/QDWfYTRXLHo0jOe9PTk0dskLuN6Ohwh4RH6cgby+kjyr9yTGojnckuPRrnSIQftI5p25w
rfXQVYecFvI1c9DociDqrN8SYDAf8IQwDqnwLh16y2M9TtpOPPQ9sQewiEYwSf4Q+dFB10ZQoxBw
xJ1dknuBmHWuSZcXdTK/Z/6czjDlsEbt5sWx4xv89JG9LuKgf7d6EV3ZUablLfGSCdVs3NGOLPPF
erUoMt7oh6MfSj0HtlxymiKiOnqENf4q9VvvLjDGR10p68CQ0P5a9CLRuwzLSc+Ec/YShrUzqXsf
zjwwR3KSnjLadZZ5ODWUrtDnVDC+pLSR6E8vfbmDi9AVX7KU7sWOfH+6K5nqaLcvamqju6TMEHyw
/EN1FWOcy6/p4BbiK0Qrb77PUZNMh6WDTXdVzIQEWkSzkGiAO4XitFQ7W0u7tZmfCJ3bew5IGQBf
aWW5eWjMObU+kJBJEjEMYjSyjTmokiQO5Wr5SofYTJnCEIvylVFyhtbftxPaHWM31tW46/0Ahz5A
2NZn1mMVdnxiuI94eGt2PJSbpbKCbIMeqK/fKeSG+OCOcyvvm1l16SPq/N6ckHWkBXpuX9eMlpXV
qv6mN9khrpSPEqgldsUs8PPhoxEbyQjLXrnpIAKKKFsyzDQYFNmltA5ePdXHnDbJLndHgK9TX135
LWNYdA4nShlN33/IlnulY/mlydv4GGXC2sbSHVGreURXBDJ/x8E5oyXMfSKYz5pyihms/5yptxrm
M1rlvNxlJLogHzclnaoFsWu15nBtraNp1kdr9It5JZcqf/A5wEsqB0jIST4MTySHdkfWuAzJvPYu
qoz5XhRM37LMia/mJnooOO/e1bmOL8xC8r3X1D6858Djik48D50XeNdlM9sPfmFJBDFkpO9MVsKL
yXdzHKVRNm0XY1y2lGveo+l2+jbAOXVRGEpddpQOa1KkvBAdtQGE0U5mZAH2+OyUDmOksbUJbkgD
FlM03Z25ay2wp6q3/aPpD5z0iR+pdlnuj3sNu+bVqgAYj1bqEBnBhBACswPUFVjqqrEjPxTo+fBG
MSAmEMc4WCD6TsPY3wjFjCEbenMbVxOUw1ajgIhyz1vNHVFGFjKkBxSnQxhkajjO3Rxw2s7RnIvS
XHvjgsDImN/dEWWx67bdnerndG+Yqb/mrGPSLbPmreXkEToAQxydFMn4kkzJS7zkEhPTJEMcPd1W
zkN0SMv2PgcltvU8nJST78U7zuMMswpGDnAv68vM6LDWGE16GFMP/3jHPHtFwILx0CbNu+UG3Tad
p+El9uVw26qOs2bMiVi0C2VsMoEddpKjWWUWpZ0ZrDFljQcvK95iDcOVvj5XlVtenGJd8lt81FIu
oYfhPA8EpzQM8J2uzjccN4N9YnnTYUC8fJoZuUNitryj44/NYezS5kJFEE+srg+1h5qVLcvd1OBF
904f9GHrjtNpwE4JgtaNTnGdRDvbcC3UV3X3tlC3bgQ9gQNHwQh3ZTnsKWLeJZdwg3PMumuncQv8
LbnM46zaC2+xj46O/NfCRIWBypmkLAeBLxGDkarX56nGTVORWjsRrvFqpXT2VoXfMmFN4b6SMmPf
iAT6kRFH6NYxF1Kl0cWtnhwQ9jWKknVnmNadQRJxaPRJu6UVAATWKovbUZr3Y8dg1S4zpBEm+JqS
qfmWoBW8M7ntX0wkcz0Hi3RDSqMzRn3+IJ6FpSW1O/I3DBVlGAwDg1ljsSAva6LMvjdzKirLn5eO
v5vDneLJ3SRT19ErqX3cqoL0sSiGMF83xgnIHRbKDp83Y89aXSH7ZRd36FvSHAB3223R0MnbNvba
Syufs2+Tju3+kqCrLIW2HRl0ssW4kvXAsKfDGtqIBMkuIrHCxmjq+Ww78cvgx51AXoi6dgSZ3PeR
Z2yS2MhajEmBm9LQztYjSS+FxnFLjkw0aKbhWWKb5wveJeY96bVWb86HafCiYT2SJT5c+Z7Rl18d
Ib3ozfKGJUcmFbvqi+oFZjaCurh5q4AohpomZKm+FFQ5axlM2T7r3fSGoixhyJ8UD7lbFWjWU21T
FUkbd0owwlOuqikr14Nf1ncKdVNY5ZE4ZYGnNl3n0pluyhk/our1PkeHG0722csnG+LhYIzjOO6H
ZK18uzuIdBgPhrGklzpxy6dqmGnPFY2sPyYr4mDlQhk88zvqMEIkvrXb4pE8rQAHqSEvYNaf017z
7GTIOHujtWc/GgM9v41S7kBE2KQuigkx1BpXp8+jHyzPfU+6U1nn5XaetPs1WxZn7VmpsYu1fJsi
TOgmI+FbfyyCC7/01J0capYNfiC3TUbT8hBkaWKsSFtHCFbTNetz777p0du4WTbST14M/8OaUzqs
apKPrVu+RNGi7vEeMQtJk0ze9tZob9vzomWSqD2t8OIW20JNrjo2dBSCcI47635yopJwGaOosp22
K/s0EE39ZZ6De1Em/k3D6XfrJbQAxJLQtssMwu/mEdomfeCmwK1T0R32UEV/mUenPKUZPEgyBZuT
vcQDTfw2Rbcoi32djJa1kp0/PPipN18S9EBwpIHRGlO/Ox78jMFS6bYeG4Z+NwKkHWoUeAYqp3pR
csGRH40B0+q8nl1cQ/U8rapUkCChQNkQGYWsmOaeb74MdoupphfNMJ6DEbznyW+dD12a/SM741it
FSQavsAhx6aWsIbPtjhkXiYeksW3TpBP46cSv/Z73i3xHMZDPT+OuMz2ci7PW3k5JWcduXWi6dSf
Em82T2fn5UXOj6CbaDTmpS6191AJ1QLfpsdJQZ9jRROacwyDoeSRwV58ckik1VttG+p+FJOFSASh
EGlH8+yvOWtE/RcMP2kL56N2pq8z/pM73ikJdAy+US1Mub3ugMRb7z49fBfbUN8t17Rm5/i5zanH
rrNBjD5CFQ/0MDo53GsPuPXT5mQYdYS+2fZtuM2YRCpWNCoYZlJFDRD6Iihb9vOhmw33JEZT95u4
tAn2IF8OtZATT7LayjHIETdYfh7vfXdkjI9nBrsNiQVzn0b7TpQH327ZkKkLCC9qn/lcDSDysedt
80TRcDEJfCra5lDaU3tpTFgPJ0yDORnwp4VJ4m3fEr5V5kwNyjJAeDZNJAgMLvHV0pnPTivOFMKI
Q7fJjomL5l8mBaZdXM8HT8bewXXLV1wvt4M1tgyc2PQxXr5GFif0hqc6hEhr7AyX6G0ysrJvPKD2
fczSvXbUZL2qaU4eRRvkSIYBPOOF804sph5HbprhWwPR0lvvQQebo9F+MxtHKsSJ9fwx957Ue6cz
loRSaSZMf1woB0NReF12xSne+8Ik2NQX0yhwnDlZoVoc/0NWPJfpMn+NhcPWl86mX+xL4Y3tISki
3hkdM2vfjpP8MhCOhPnFiQKizrBbkytlF3MSLoHjHojd5vswUnwEa10KKDsmyTIkgOaZgbg/8up2
b9p+Y298WacDtRe06JMsOZkdBoJVHRTz7tRfLz4OpzcUFpG1SRAhfaRex8xnbmsaer3N1rPy6eH5
SNIXmbxJVTrGCXmiLG8NOfLV+YwSCL8abJZz14MgCOocuR+MqBlDcJPioHXmhmgS12baeltE6Oth
1/VNfCvcQkYnZ+waIhrGiPyUkj6iuzH4UF9Hz63qK5/Sz1v7BAG622HUiG7zDGUbahciGkNDJswT
yeJDBgRylH1At0W918gliF2hp7k3suEJE0NxETlOsLGXMx88C8zrJqnTLcE+zt6Ksu7DpAX7ZRjt
ZCXhVz2TTKY3DdLJXWREzS6rKjZMafnFqrUkmo+E8fT7MkZIlyrbLvaOWVhHf66CTWt6L0Xnjtz5
piwvkq43LuLJoquZ4zrPkSxCB+ePxVVbv49WWZLdwbHgA9uTx/jRKoJNuTDjRnFUdHvD7dTnUuj6
Ap5S9N7QQWENdBs7CHNTk5csMLKs6Ky0y7pSOtGb2KEIzEy72TGEX7aELuQGyu4awnNsqVvwfdFx
EfG4k0Zg3SxmpTdTrcVWxupJ1suylYUHbDfKu+NYY/Ag98i6RBVtneI8k2eNZue/BCmCJG2Z6t1m
eHksUPJsZwv0Tpn71qfRqO6Y0KO5w6Yn8Ne2PprQRSIVFew2q8EdCjROCblklmNTv/PAb92zuDXW
2H3JNr21FzrL5WxHxwmmQ0h5nR9kYvdqE+VOcKnUkoUQj937mgDuRxXH+aEiRccJS840B9zRC8pB
izSlpc3CAv/BMZnqCV+PyPcKatTKjVWzacZUnUzQ8hGWw7Z5Jd3inBrH+HygodgXlbpQhgHOx7Bc
cvMM127kNU5iCIW56FB2rrDPBOpHg/W/Epp/fNeV/FXHcehSlQ79T+llZy3Kj7ajZ/9O0DUtHQSa
JI2ZAa3nH21H1/sdZ5FlmbYNENMBofWvrqNBbxGFzDlSOuCP/pxehvjGteChnOPLIG+BI/5P+o5k
nf1RiHVuXbomiWWQHlgEaO7/ElytOWdXeY67usqluDBaOT96bUaC5PkkutZqYmZC4miYtYpphap1
9jaZk/zWtjhL/9Cr/Tf983N7/P80Yd/fCh3Y86eiDesg/Pq5S18hTjEgQSxrpmyAzi1Ph9JIhz2Q
RkmMjJOoWxoW0UdL4sjfJK3/mhcOpgFFEnInLoQUUBt+fmk6mMbU27oOAyN58pXA6FPNXzOmy8T1
2H/zYj9PIxDQ2J6LoCogDZ1/d4JfXqxZOo9pq9+E+IyWcEmGN7shR/Svv8x//yLU0uTjcY/5v7wI
3cMuLlzkQ1aZigMG0TGkQWbf//WrfIe2/PGaYbPwEIEhI+GzoIT55fbxksCi5B9UqILruLmvJkDw
7S0CfB0/tYg4osk6h6WGDOVoOrjn4Ct2KyfMa2J/aWc1YgkHW4SaKF1/CI58LauCelXMzSbS7wDY
LpS+jgwn/Os37vB0/XSz8cbp3eNDgs0tABudf/0P0BGgZJ0RK/TgKCvINBnIVF62Oefx58jHtrqN
yPMj+6M23+yz0Xw26gDVcpQzBxxrWtCgRDIyojo9h8tC52LdlMH8nNojXUfGXP6LQ/vhNiirocZB
BBGKiBszDZk42reKjuJD0iUpTowRz2BHFnF0SESvrkbBRToAPkIYZVkQ2VZ1Z1hyNQ6xHxyCvpNU
v6QzuOugTI2nKrOfujlu473dDUhPOKpJsUHRQ7FsNz2BVYvn4qz4my/vT9/dmbR7JgaY0uI8eF5T
/vjduQ3aO+ybIV7q/GSY0bDp0kD+zav86ZmU4EbdMyOP9YAkx1/uYJXOfSmUQIJnqjYMVGfRtkcF
5cyjSYiPVa3/+lMxGvrljrCBE7g2MyYWbPdX8KhH7rE7JB3iK0nRBp7RZpLbkhPYZCYKqppI8wVH
1l+/6L/5kN9T85lNorS03F9EjByNCL306ITLfLhhYsJWn/TEsNkBIgKirf/61f60KJy3IYZFxIex
4lvmLzMmzc0x0n3FBJFkw7rsCEEaAjqBf/0q4k8vE3hAE1nfYEmw6Xm/XDl7whc3+FYQ9kODx93L
dJluKr/BANjWqf9AO+/SGDovDnVsQfVcWlluq9QhsgvFp3yA3OBet0FhvVvGGL19f3f/Par8Q5yF
tX+4VH/S+173qqvH37BavvVM2H77f//61/Q35n5v1edPp5gfP+7HOQZAyO8uvNfA80z2Zp6S/3+O
Ybv+nccT4gRw4F/EwM7vjMPPJxl+HQCfx/32zxDWsxiYHwLDisebKob19z8QA9vfF4P/24fORyTI
W6znZOtICa7zlyWprX3PwpLSPbpjdpcrwzm1qNE2npu91+p/2TuT5biRLku/S++RhtEBmLX1IuYI
MjhLpLiBcRAxAw7AHdPT1wcp66+k8u/MykUt2qyXkigiBsDd773nfEfLbcK0b1PqRr6qTIW7HFsG
2ABXnIUt5Qs2oGmrmmrepUHhXWGTmXF0Vw2F0ogfFLf0SjTzV9cZbRj0ld7pFiyAkcBuLMt42vdQ
4yjgsMp4ZuReTOFQo8kY6S9het3TEWIV6dzbqZvpIVn5i+NX0xFyH1eZ+W0leuAFk5dsauUC5jQy
qmvfzHdzN2AuaSVylh68BtkFkk5exGiyTi5qhcvbCsXOn2gahXH13HRQZUIy866C3GuPflC8Wmw3
SJIu0zZ7p059Tf2W2pi/CCPzq5tAHadPugvq+VtXYAbs8uaeLLpLwwy6lZPN6V6MKAJ7o35Oggm8
TK3glHtoj8iNMLazK3ICoEChs2l+2EF0cqsxOvlIbQ70gF8TBDrrLqnvY78/j7JrVn6qGgwUkA9g
k3dr3WWvvtv2qySe0j1mO1jXCFoeGmkVzC3S5DpAKIy8uZ6ni8hT0561wUaBV99UDgyY2M44S4w+
g9+QL6l1I+tylOIKDMC0n8R4I5tnU3E1CqPnJftu7Q70ncyBT2H5q1oUz8PU3lcTc7KZ8speoAyE
bSCdajJAeb3xBjmo3gQWSBvaZudkygf0dIm/LWO3oCMtHnSVvhvCRAnDdBMTBVOiYhpPXdGmfPdM
8zHKWbh89ai2kA4nPE4wg8bUbM9otG/tMG6fcKfSNG77kMNA9sFs+5RPy2vUxXOIUXyDc5niEmpi
M/N9pFmid0XVyWeZhYgFGASvGljkl05V1gfGZO7VtNw6o9Odw9DDiFT3+pJFWV9CjnABwc2L+Bg4
pn1XoE97pefT3KazfpKDh0FWBygEHbgX6avEBgBDoL5PhBqv5Fg9MwO/Bz1PWlBW3TPy/cgaol7M
8obzC+gYWlO7rjXybWaXrz7ekmlpn7ouMIHUBdngO914qmp86W6FMC5chtKIZek6yPuQ4d0K6hKs
3Ao3cO09WLSivYiJnEfLelenTJ5zyIIYtfP0Cl9mt6mhbKwFQalfNdbzyyzyNSrq3KjX2VTc2C0G
35FGnBNX9xgY5XoKkw9vwv1ZBCPnr4LbLq0+6NkbYPQNolDtBbgOwWWfcjzfRaWR4vYc801YDmc6
38+zwI5pxFV9KDI+2hFdb0XWBbYD+t206Q24ZmL21K5nmr5V8XwePO6Z0eP7NFPf2dE/wr7nKutS
Mrq/Tu2u2s9ocPGXozmXXhdv67AFJBs73nqwFq5nzi9AgAj1gQgY0JRTscJr96RGFgQ9sZFKMir2
kMmTd1WHb06KOzgy0o8IP6VH2wj0Aqc1Fzpr3DfeDQb3V4eq4SjQvhP8O1f7MOYD0IjCNnbMFZuw
cjemMX/lkxQEJZjnAi0qUIGc+At3QjfpMcUzu+S9T4czM4uPYCxgtWUSPLELIBDpKyICmpKbLiR8
dcgU04LYHo9+QSvDsdsnarnX1jZfArMHIIx+dF+Jajw1kc53Fg/3ys3h2uVuba+DKUzJfO5Zacla
2HKGMKBi1OZGTl5zQkGiDyjc5TWkg/kQjFEDqiCBixnIiiCdqn2VtdArOtbkHff6/OO+8VQil4cN
3XfAIxW2MwY7+uoH0+ImG1mPDoj5TGa9KeoaV/8Mw/ofOIacwUbXXf2h/vfyy99q6sOUcJn/8/mP
3c8/x9/rZdv/9IftD8vPrf7eTnffWTH4rz8Tgpef/O/+4+/GoYdJYhx6q3Wllt8Wp3X1xzODvYQ/
/9+7Jff6/eXPP//zhOEE9ENAXvmuySHDDxeB1O92I+u3gMYEIdKhAwaeYKN/dUpspFvUnbbJuTBY
Atn4p99PGOFvLv4kDiyhi+dtSUT8JycMLvapPPAdhCyOT+GOlJAUMxIkPxc9btBgN1LiqWtnLR7Y
ORs/WMcEmZjtJRtq7H+P2VbYk1Q103B8plFv2NM2BrMHShxdr4kcHkenMMcwJ0O3LAMrWRdumMzh
vnPnIl1H0nGUfeWgjyHKEIsncoQsIeq8WJfYoLpDXgINAFg5ZNXGiJTosrOu3RjNDpMi+yobU8Gv
1gbyLLjKtVmDvW1EaSX7eOwC8RoTgTTlbPdT1SkMdY6X+wc8Q04PJqPwA2KGnERsYRmQQluNc8pe
HRKsUO8DNOXDmiiGMY132pvw3KxnMkByIAz0WJkwGbGGdgRpud3QM2kY74Nq8z1aStLz3rMKJyCA
T0wku2lCTiRXUeJW6c63u5I52xy0FFl6XGD1VctwDZM+x57Z1WW99jFoqY3kDlHrOJDqzEIHU4rw
Drf9XpvDcF92QIg+nBr6IRYYr2TFwzPkN6+ZJhTrCudAjS3VY2Mnwnhqc2/VsFzpFvGV59B1b4JF
LOSOQXBUXcZZZqpdgOorMHKhvjC7UiNPAPdFwItd4LMIHKt+jCyFZi1ojf6IlWFm/hCbI7z3omhu
dAMZezWGrr7nK/P0l46Tj3PRGG6eT0R0aYdFMwB71OQz50y7od2b6bgT6waMjtrl8Tzw8mzixn00
TSb8qKKq7HdP+SF7RNDiTs0906aJBEN7yWmZVHVikBjXWxAC9nscES21bqIaqK0/AeJfVbkT65Mn
BvORJZemtctEJVmlniUV0oK59G9pWSTgyYawZH+pSVeHbaM4la2q4YegVS0iPVQfvEs2vTl8tIrS
9VEvKF9ug9zpPfLRaTyPZBdYCQnC0Uii8qosEBVQ+rlF36wSaevgGkUFgSprOwBssckZ/b0PkYOS
BMMQ2cHHHhWy8xKDWnaeTFnHKIz6xoD4DjPY7e1jVXezk+1B/UXsrFQ99graFUKbMZZwShhCOdec
5MAAoZWG0oOxghc1p7UkyMiFvAWpHAUDvgKUQ/s8QCWyGpMsudGW1727ukW4h3cFTBMqIjblyZHA
gocJUMyKQUR8w1M7fuXO5WMcTLB3JCZnnrcG9aKu2yTnV9sJDlzcMVEbbonJ6sJdqB35LWSg2G1p
9EdYDnt23zhr1TOmAfPej2b3eaa5+lU20BZAuDvVZdEyBzkEfhEPgDUTDbxB2kBzO88Mh02iBc6i
2c242QpZuIQ/tbYvAKdCLgMRFYQpp3ET7EwwiProekU9ovga+7ugDNsnDNAYZSTKIWsN+ZVXXUVk
ADGsFP23BucYFBZzKoaDNN2pRnduzDt/8IrgeUxMBVe+c5HjXyvEtfDuZQzbiXACRrSrYgy66qRE
KvSO5WoC4cZBTWH4D+ziXMWqJipgmOsyhD5TeZikbAEXUDNCKpmzrakd/fkRx5KR3CEjVGO6NpoB
lw4P4DSPegWupyEozOExxXoBU6YBrGmTWdDP2CX3dtglkF981CBmv3Ehs7RHppZwDIe+Bh4OKL4R
F0ZsuOpIa6fpzpNOAihFEBx91DV1FYAEDZuxXRt+bYLSss02mNFs4FPk7Qmgim+2Yyb98xhGZNIC
DURHh7bCMh7BWGc2zowCskwvsJiNE+EYietL6zWknzoz+cmM2C45jjmUOwd0JyL+Mpudd53GZdut
FD4xOFM9WDbMeK6zt0XfgpBjLGSK8glfAAtZ2Buk/zG0s+YJGYzAqeoF7oWt02gGo5WrRyIjcpjc
2pb6rkqFJY9JAmBhJXhgknvgumQgIlKtgHg7qDJXTh1is/SR6YQ7ggntZGsrKv+7uOxMHxVdpG4D
C33MukUhW6zs0sjGfTjJKNo02VBeRX1jE2eA2JpTHaFUuzLSI5Q9MymvOs+FMliIGWhKTKch5TDs
cbYL/Q5LZTeQT3X2miHjZEfOploZjUNrCMloftU71syG2nkMYlYihGOruiKa9o1RlMO+m5LoJqrT
JAI1zAD4yK5ggtsRqvlOvJp8EhUH5h2QP/+MuE+eMeg2y61hmqcyJkt4NWDjzw4z4QQtfqBuNo+p
6NhBa/ZeexNZLCo736hFvEt0gfF3ncl+AjE3qf7FqEv5HhP8QiO0tdGIwDaVRFqgBerWtonfYNWL
gSStIu5Aq9iRa56Gqc7aDdqdgOZwXlIOrjoAXfmqaVAsr1RYihTQDjabTeDH1kXqNBMkG98bnvEf
iHE1tmFS7KJKYl1iC6ekJr4rhkMTwFxcTzbJHq4fYwmZZnwjsPJET+YH/qpdnEnveZSLwGpV5L5s
mLRbkIfHmlb2gfmhmu9E05HzFTqOs8d1K+oTN9QISCscoVy37SDumd2CzMsoWt9FBB13bWg1newC
ZNJGtnZQ7xwp+/ZKg2o+xcR9gEcAR0cFVVyFYY9HJjCm6qXUnXwYjA7P79gL8FMrdA7ofBrSs9N1
GlfW9GUSiZFsJLoN4xB1tg07xx1pVDSZhd8yyef6iGOGlZ8DSHLLSuJ8c2qdpweaWOl3j2+ZDxQA
uP3UK9vVX6oAmM3eEKQ5oL8LE/uErrM395XfNwAklD+zBsGd7jgONJ61VQL3lHE7Mr9W7ylhgvaw
hlNpZ6A9w5mYhdR+BaQV3y/RAqhMEst8w5calQDa4DKRvtGUejvxWd8hekJHGAE0WTa+pH0Qg2W+
08xHDdQmmLrBnjnzW4GUhmXWK4FqBKj11SrxK/8lH53AXnGWs5IVrn3nwlRezjfcTRVNHE4xwxaf
vH30Sj6IlahcQqqy1O3PSWwRRdO20vzSVorUOb8OOVTEOEYlOAVpMYZoYpo7FSmDLMeq4MVn1ty8
li1KKMCgiXoJrVqdEFkkj0ya6zsrEZO99afcZVRN1uw5remqr7gVOWYh8xIYFZRq1IY48vDYZWb5
0cPGuex8FX10NPCfNMc/uSeRzNvjy9X5uk3nocH1hfLrqAxY8sxGGCCNXhN9hTjbfSReWEePTZs5
OTsbAjuUeHlifxuxJPcPtRC5X63jRFc+HYzWokYnLo2x0h8KlpufLcU/MjQ+N+yXMoAeOgOjZeol
4BbZn8uAkPI5NXhTq8VYUfJNEPVL4IzZ3aY+OnRuTDrs//SaEOeoPGzHZsxm0m78fE1IDF4fdKm/
8q28vHAdGexJmSQFNxrnbV4APPzr97gM7f7QTHVsrucvU1imw9Q6v17PM0ZIw9zqK5QKt4L9ds1n
rLfgz8NtbIA3JJWh39ga6YjDGfGfmbWWq/uLDYaALsaWdJ4+v9uZ1p1KLDJaxlqYgECJ0hntpXX9
r7rz33yNyyz581sMfWZYFJuYezwKz88XyRRwtJHFHIQcAEo5LY7DDvvjkk5S/5w4/Kyh/9vXgomB
w8d2iF//fK3IyjoIBRgIkIuGGxUb5WODe/VStwjE/2728qf70w3p25suBiOir1Hjfr4YfuphLmiB
UtOw+ggMvZxbS4JFW6R42CSLYSs5dW+aMcO5UjrBKzN3sU2chgOnjFkXhsBFENeoF1lU02mGZfvP
cs15hpbX6PtCAAmmcHeWSdwf5od9DGkISLdAKxiQhNyniJFQFO9+fMX/Ax2W/+fi9ASrzr/u9j+N
ec4viyblV7ILO9N/ilIM9zc2CFaTBcMTMM70/zXNMQjH44kwwbNACqeGWMag/2mG83+DEMqghUF/
SJaD4J+6WqsEX54LKwZzHeshIop/Os75PD/E/GYx8KV749FnEcwpf3lgbKGWfnX6nAbsCLATopUe
Gcb/4TP526fy94v4IWk8yxoAE+nzTeiWpU+5Hj8PQZ4cqkmFcE4N42TKQfzNM/lv3w59KPDgpIOz
e3y+UuzNYRFO4TeLU4BcWUPY36mpwhbz12/oz5dBmOZwwhfCFnxzv1xGD1CzyHd+GszGMrc05PXD
6BUgn//6Mp83h+Vz4zIsYjTC6Jcw3f38bqg90yCgLK/Mydo2viT0FW7BLg4y+LHo16DP1O7ZH5rg
5EyF/Js3+Vkj9PPquHhNz8Gzg3Tjl+Ut5y7UrWs+YYyINo5VKmJBGKJsXDLRyRUrbVrCImOClzZ/
sy39u/ftsaJCzeKx4Zn5/L7rtIbvYs1PjR3DDB7hRsJYEB0ST4p5wzxA4IFCL8bIL3a1ZysfXJBE
FfzXn/7nfevn+xeezZfAnYs04pdXIaZUFrO0n3SGgR3ZEpMyA4QjYQb/+EKhANFlmThfBRKFX75m
EKsJ0lnniaSvZhdpr9kSQkJg7BjHx79+Swit+Oj+azPmTbE3Bvy1x+yWPcH/ZcevwDVx0yZX8+TE
9FoY1ULTjJhtrIJalgToDbBk6KrQlAQUwXwxjOnMUAhTRHaTmB244QuFt1Okd2+qRSAf+XB0V2gM
nJdyUPQxYoujKakAQJU3Yh7zetv/EOP302xjtG9Thh6GSfoQqMiKAKbgh6S/nUsaYmQuWG+BHbjg
r/s5CVcubhp75Vh5TJ3qxn25qhpy9SgrHKe7iDi/nwNv1pcphee4I4QqIPWw0fIlKBGEnTsDa91t
QG/jEUPJ7BNKMpr1gWiZkDS6HyaK3HJ6ZJtCNzu3HZhUzUB4udfh0NyLfmEG0Rdf5KATWQDr8ofH
wyzK+h11S+ZtCzMr+mPk2u3DBLgyXAkJJIiKD4jAgVDp7igjmZjrGfI/wSo/LCveTJRCTOaxz1gs
gpzXe+PUPzCHnp2LuRLQP0sITs+JUSXvrUlDd7VUPzhrEAFgs7HawIxfNWjMu7n3DHXV//DjjGMb
EONO2Wrwwe5NI0ugDSvboWVBFN3i44Hr5Bi3IJY79LRkilQdMlX8lc2c30S/W4BKoyhCLEGkpyjL
2E6SYalcuXLAcn+F0BoH2zcp6zRjoDq7P6CQg1d2d7Tn4cqRM1mQFHQ/1GGtaFm0TUssl0OPhFA0
MGGNuYON3dvIpnIvkV5AOgveXKx+5QRfIngoC0RWCdlESJAsTH1+ypcPvcZLxhYaBcJnxwVjQsv5
Mep7R7sYdHwt41VBr9qNjr0UATJojbJTPRTjNFO6OdA0P+bW0UsukikaYKC0MmVEoHFc6enGs7Gs
mDCSpNNme5FN3kAtX5pGVX3pkjarSfeLQsvxVnUjQfdC1YnBv5RpLJtj2HRkBmjVmHBuQjM3L/o+
Eua+g5n1QQNiwIPntME5TEQsjwDPgkcH6IqEzCGK71lR2/GHHFvtXnVouZNV2xC3d23HvXGNYzWN
9nj30EpOQWI3ayuoTHvvt2M504nx+lu8vF58PcrYmBejVfZtrFXm7/vWDDzsr+5s8WHYw1g/JjZu
mH0yi8C5VIS5C9jzIVPgwVtUnsjOLULOl1mnyG2zWZVzV6Vbi5B1cNqET9t7Yxh9+Ron+UisTuyM
84YUcMbZK5d4BMwl6NTiJ4LR+3angNkYX6ZB9c6DNfdRdJ0qDU81mBzTe2Iy4jkPkyjpatA/bcRb
x8CwZyhSTpZFhowu7ZpcIiukdzLyuENuNBtBoRLBS1OkFEKLd9a9qQZGn03X9tmXfE5bkmvSNgEO
Ozl15dFVYnihWWtAVlwaXQw3Mklixi1WJm4mykmQkcIgtKEa+uK28wSuUAviewiu00YjblGxAH7P
OiEJG5P25UAsXwLjtS1uLawMN5QVGbOItospNgqZjmyOkcckyUutD93wge46BATBuup6Jkvow0nU
wWKIzbcc+uRcsrJ064lw+3Qv044dNi0Z8O7tUUS3MWaOrx0DKnM9VovKkAz3CJJmSftlTaYZVODK
7fuHCMPxl9ogbWLjQo+K4W3M7bDrMzrCO9tgMr6yK51W64i0eqyafvqtmwbkAW2SjTeWm3gO9DUj
TyG2RrBk0yrusfBVXnk9OPBM8Xyl3tcKKvRzoDR8by83om8msJg3TQw5J58BgrCf2Nn3hJh6QFZd
2j0LwzTPsiE7AuNummPO18pMtgNhcd8QxZcAmgCGSahXnQE40KrDZy+sUgDFbltdQN1VYo2ft3tE
XJF8mwKvfE3sQdL0bqvmVZW1MRKNRTovOok63Sc0i66q0SJcJzdcU+8CZj79JnPm9NXzS++WdmRB
4JB2XrLSGMWazhim/16RaG8R7vecjJb7RZvG8MYKRTYZVsow2LDNWWTz+q2dryVjph25o3StjDnx
P8Z4DOYVXKheY4chaRdlQDtwBxZhZaBD0ebdbCPS4SIt2HMpGpAxqTcXOROCyDJ2vGkID+Uc5opM
UeY7cMuWzJKsKhm5ldrG2oDqlAaqE+fDFQ6sgVgNW0w3k+faHzrN1WVn9OQu8A0MG8HGShhYrun6
8+hEVzVJ2c1GuAE96iqcaeg7iM7LTRC0sAFpAeHnq2EavDHPx5zh9mNKIOecx29T5mP6V2Hi0MKa
DNZCSJQLV2Ly6quCEAdC8OZBvraD18F+tXq+F4bY5YsI2sba0CAyoNhPlcesofErzCAm0Q4kXEgS
O/jpFqp00PU5sLFaXybY6wWu267Kdo0BeIhHpgITGVXgJexoGVq2OBbztW9L787pFsPcj3PR/69f
/xcdnj8cEf9Uv36ZX7+DZ6KC/SQtWP7TT6mA7/xGDcL02PUEsDixAFt+N1V4v2GZ8Dz66otc4I+m
CmSKCBgRFiBY8lnOFpzp79WrQyD8ojCA8kJZbFL8/hOpwHIE/6/TLBWe73LlHx0sh1f4q7xf0TwP
EqcghjZifp4BBNpz9Bn2Me3SbUUL+2HAC37zh0/o31Szn6uT5aKUfC5ZZBB1UWQ6vxyhHdWTduD6
6UHoEt9EQ9xRs0GuQPhAbeWRC5fYKs45vAxaXkXSiVWfFEQf/vWr+HyQ//kqbE7z1A1If/1fD/II
f4em5ux5aJLymEIIiGyCuuKZnjl99GdwUA9QY9/++qJL8/VPH/nSRcIsZwYLxOfXqjCFeDUZXlfj
mFTDF+1BXWNPn+56j/wDvgdnvBUKj/FFJFrvnSlw526aqUZZYOmJ9I5snN5aNQ7uM7Y++5GcFQmf
OZsd8QXLF+fp0PE0Oby4+9rDMhQq7r1caPvSGvtiDwGz2jiyrK76sNWIPp0Q4IGhxQ0K96sGnkq8
4tA42otWrR4uSDvnIDlp55FJGTkxcgoQaBVhu+G7a7JjtWgZ19kI8BiXMIdZSpoMfnxtwmsEPGvn
X0SYVN9zSb27moFRoxs4coLyjpUe4u8IZamFYYwejCEHECDjcG9zlJahvgmH5BGUirvxSUm8JaAY
pJwfqfuWjt9xsmx5bYJPgZdYmR/ADyF/9NV9sMx8UDsygZE2g17T0ps+4iKY62zUaFW+J42RQPeR
cApwoN4mMfQ3q2lfmyh6MgrH2w6lsPeh5LCPUx1dw4KpCJTxAfRCFSv4Jl21wlnIdFsE1clzCvGq
puAUl2lIJgJvEThi9V0GwntDPc5ZFwSledfH7mPpZ+0W0MEFIxpNhIDB7bNNmxGxOSPP9KALRJFn
rav6mpkYdLmyb/ZQJ6fvEE5VR0qNYFCWaACWmFRlXNzo0QCzYOZq8Sn33keNRSTlc2/y7IIfHjiB
KM9aR9Cx+VIm4T6N2LOdVRJolDChrwf/Gi9/GwJazxlVy7oy3G/taCGWUZEumzubWQccNL6o8YCc
hKopNLr+3DQ+RELUCfZJ5C6+cjdcQosVD1rAcWui6puRl+qDV0F5Msaa7BYoMaO+iHWoHqKw1ndJ
npXks1IRdWsj0snRqh0F7p3uHXBFO8XLCH3SrkivZGZDKnDFYCoHb3Twa87Hx7HPAPrm7Jhv4ejr
L8VcTdQ7pYFVOqih06zlsGDmrF4XA0LFrLEIG28scY2ydsrcleOmoVoFZTJ7qD7zqX8lEbe0SVLQ
YMQR5mKuqBrt4bDJyRPJBvJGt1NSS2TbLp5adADVMyAvc0HKQ77cRgYI/j1NgemOglIZYJNAJj30
CmXChRwnwqnLIm+RyWhVEfHdx4Te4+ZHPEm+BnQDUtpFtRtVVsdbiyKzPtm84wcAjuhAlGZsuyZb
LDDxYYvYPrpZypCsdkA73adxFk87Ry4hNplo6nWiFpFFURaBPmHhLLE3K6ekq1fExrVPiLHLC+hQ
kM601gmhQjGF6Bd5BAOuQLjTt0wnoiO2vA6/wNp3ivsR63GxSTM7eKA3MXxVNRmESJ3G5gqZEAnS
jgC5v62T1LM3Q9Wm+TeearXkqOPwfFy6GNBZJiNZkPVJEB5KpJDnDGrFSOKsjVKUTMpO3DsgwNJ3
5Qj+K4mNo39ii3QI8WS0U14wduqOPbBVIKh+NeBvoi9SbATmdg7zrT29MYKTyQVxsGhkS0yD6KWw
V0UrpjXtEmkXzrusGIYLp6uSO494LG9nCDpgG9cg9WHnybZ645iJ36syyWTgk0zRGnBA01+QzkCR
LDNb34dgVjVbVjZXxza0cyztc5lVFzy5TnQ5pG2UY28a5zt3VHBBG8CmYrWUV9GGqpGpce7VQLtm
8lBJpgkN/T00S49zfUtYZtR4Xr834K/Mm4ll6M3sXfK462QIn60qm178CtHdg7Q9cWWOPkk5pozy
vRRY2ppCLboM4Qw+EcFu+OSZc6wu6ilIe+a24G2oxrroAsqUGA/5UFYzrvq8EWsyvso33ynCW2jf
HblBZpjAciZ+aJUIf3wpilYS29IRgUm9wyy/x0uxogNpPGDmt2+MCuIp6pEkwR1XlvjTEeabK8eb
fERVSGw3ACeI7e6Bbi6arkScPPTn7Z6QilHfFi0LxdmSqG3ObRTVLU2TOEkPHfHVxMXB4YGxOlTF
nmN4jQCI1mm+7oQD82NSmete5a0EVOzBiLzJvUJeG4qA0xX8Uac4MoAK2S3MpUi1R24kgqe7OdsY
tU1agiYUelzDP2yGLdtxdE0+WHsJVKuNb6BcRvMWYi6JXryQZxbT+DpEH4foDszHgT5HslC6O4x0
87EZQcmSI8ymtspbVT3JIEeE5nG7XKCMEWKJjKgfUEwTZWZHRnYM4TVcpUllXKe93bcED1sN9wUw
+HYfawhUSktyxUbW+8IxL23baq9KE6vFY4jIsVrbrTSSnQpq/SUHDH0jR1OTIk4FeKPJByVvhIRX
cz+4JcGVjehMl07EhFzENqaJqnpaYh9SUB5XbLKchvDY2vqSUXpm7ppmgiY/xCZxmG5Opb7pZUSP
JZqKd69g+9gUxVyieWfFMdYVfL702JqW2YKoqrrkNELq4B8VsO0gt3HVF0Zw1VjTeBc2mlBQaikA
m0OvHAWxyC3mUw22YV9PbkNOYmG17bkuaqDJpMsFEQBBq+iO3UjQGfFPbv2OyKi/DDJjGg8aMSDO
UavxzmzjA6yATvsvZG8mcoOdpTO4ycEwXfUqjb7roDdL0L9QmTcddMBuJ1ptNjvo5jE1W2gN4Gb6
OLssaLTGh74PDM0YmVPtakoswjNkA5525aK+W+di+F71iFf6TvdviriKRFrGRa3JHbaZgD+HnU03
2HpULtHLtBuZ3CyQRBvaDow4FJQCrV9gqROxh8nBAvyzZGLTdhM+WMV15wj2SXpplIOk12WXM+zZ
l4BHeDWEjv6wkxBuypBURznU7qEPZnWqlCSOrqGpbxjKIowtV9+FT9dg6sluN8Ii/xYDxSA7q7Gc
C9lEtr/2zT6/dJPCeldJ2ZwAMo0nGTZs36kT7wDHpc8+KYZfMk/eDS0aZ5qso4FwioPDYP2gIl9x
Sq12jSwuI8d5Rt2Ubem38MQxmj32ueo2Wof2IZsIGcvcTkG1V/G+sKdT0/XmQUPn30yMjFdFr6YD
wr30wgcosDWwPK59ulmkvBnFVRGU15yN6g0K2HaH0equVZD0/G6w9oK0egx95yb0R/i/0InBTOQJ
uihoBd4mKKqDLv1DDwjW1XgltDs8MXij3E8HhZQUcK6rWO5xBmRbB/nSGQIdlNve7w8sDx86rPO9
57fPP5pWcUbIsB9+NZdkHPrOW+QG9XVO0b21xuTEz0QnkFLyDffgE/g4oLcpncB8Si5w3B/apNt1
YXnLqbnGxmXeRiDh3NDwDouODT+iy7aVWNlpnkIch6gX0SDSXCfyb6t4ERiWU3GKat2uU+I4peVz
ZlI1RCyCEta4mrO7ZHYg0TW2h4fXGCI8sDPJeg4wah6lkb6w6+6QMSN9lPKG0zxtDtUP5RqEluZA
aHgvykqGC7upxINjD+KF/S656vPm2aN3fuMkhbrUgRltZU1MKIy3G9sBhNl50YPlGawUPdHilHxr
c/Kf/MQ8ty0xSJRGTO0tt0IEJAgeK5b48do7OSBHcB4H82ufz/smgQgSJt9sLazNwBhNtHRRlbGt
i4jA5QocGGbe8KzlLPeyheVj2+pMp+ZoJWP6WPXJHapdsgfleIxyU+6xuOfn0FyQ/rCN6OyVhJlK
Sz/IVrDR8btOXWLQKXHLKyFo43WB9chJBkxxMXD3Mc0QT6r1v2YD8MMRSr/HdGIvKrjKxD0v21BM
54nbfFIXTs0wIQHCuHKK0rljjFtfMJm5nWb/zkk8vS9nW1yJoQpevcHmxIQEYsfA8oJ7VD+INr/0
TedSVlF1maTGehqyc+W4pH3ksl3nZgnsjNztY6dyID1J42whd90VRr/TSKw37TzsmLySyZzk+MCB
bA4nF0yp67p3qP33zEeqA2kT8YXpNP7bNJXJUzD08QM6T8E5Miyepsq3rxJ/LOR2mHz3Ck1vBIiZ
8daqFNZtYfhIzSMSMXTkzAQXpS2rGA4hg+nYe+Sk6VdQcN7OpNcK3qaPNgbd/V00D1+LvgQAE0p5
op93qk2mXhya9K1sNZLWZH4wQyM4mHXjfxstZ4kDpy8AaczfVr2P472cTi7RqKvZKfh5xGkXDULk
HVzVm3bU4Uc9JeXLLM37qRncB+2w2Q0B/YSItX+TYYRrfSu+67MhYg0jEG22/QIMoYItsSCNiBv6
CqzuojHTdDeVmc/cohpoTAuXTsFEmNy32BbReWb5vnCCknoMvN7KScP0XKJ42NEn3RMBRGk2oGKu
mRxtfQz8NbZs2PT/wd6ZLMeNZNv2X+64UAZH58A0ED37TiQ1gYmSiL5xR4+vfwuVZfdJVJpkOb+D
mpRSQgQCcD9+zt5rG5otGUsQpDBxwwSbhZ6ZA8xrUqHTIEea1ztpSx6HTXLFvFRnAW6abMjKGL4w
UOzuMqTjN17aZxt2S4LpGADByMrUvpuyC86g6dYFyvgYkVqYc5ip3DcppzvSoYIvjksLnvMmJv3s
ekwaIOY0DpNh2yvy2zzzXPPqUJ4X3WkKTDM0tXKfJT8yOFsjC2EFVleJ0fRlWEm/ZbgQl3sxG/1B
+SStIIfsHqusuBwrYYeQoVAuihyc0EAtQMBzTpaEV5290tsCUPKfdUMnA2JA6d3Y9uAdS3MOwtnl
gFAaUXWRJOlzp6buve0pHqycKOZkiZaUNW68tGsGm7lK26sy9b72a0LfUJsn2TnHyrQPS5PBzOOc
uEHeGeyiYGnOq4r3XFQ8rO1UzwsQYFVO9BfsLtmMQ5kHDwk81LbBKefb061jm77dnowILwonUtNu
vfu0G+Ig3TXTkjgzbXPWBphUscbBa+oWKNamhdRD3lqq3LbnEB0QJBGOJcOabLNE8AULYqqsRNDE
nhv1hlK5R3g9G4XL6GGaOkwtDslRjb83bXqKbOVtPSY2qRmxWc9fxSji4NZp1VPHPHHYpVbqTukm
W/iv/KvRNHvLJ7Zi0D2kUUElyiyyTWZOTSm5sy/xhNdRf4G7WrkVtEnZemRdF71GZyVSXYFVbzwX
9zBx3K4YosPg2aWPB6W352HZW4SXpMV58ubWzrDpLXDNmg1nxsk29kkUMKXLrBFpcS2K+nPcIrmA
BWztmaCiH/YLSKZLnYkt+ng3bJ24hfaoD0FpfWXLBXNVZPpBq2xIiUS0xc5Bv7jH6zJiTykZKAb1
e90Mzb4suKetVE+ianaL79YbLAM3ujfOmTKNXWbQsUdzz3F2wXQb1KhdFWvABvCw/Tr5Qu/w1FQU
H6ArTFf1R20XjA8yMYgh7LE9IN02X0q3Lc+8inrPyA7us10aVyNDBCihRXasR6T2ZYzltKtNEmpG
11jRD96FXpy0Oy7K5H2aCVHAvWNyGuvu0r61+Trt1Dz7S1YvYdTpGOPsRPJy1ChOTpMwspugmvNX
YURZ2EUepihH1mqnFQP71YmbVlsgkjyvcQudcmvQxIT+Gzv0J2ZFxut2cSURs/QgqSRE0FinMQmI
3MEeRBD9LO3nJBXkRcdunpwtflrAxjhIHD8lb0SOxZNZZxL0oZ4uVTt622KZrycCb0+Mrr4rbADZ
bOF50APINCJEwDvtkmlWJ+I+xp1PxBDJd/VyxyArOsJHjG/QVXdPBgN8Q2OkrRjQXqMYmCktxvpd
4EDNN+1otZcaUOGlYRj3aYqa2wB/sW1ZhvbjCnv2S2Ovhb1FK1udi6QoDjgKjA7iSCG3sJfpbq0k
2XvTBaxoKhJlY3zyCJ0n7wv5tBx4vcI+tQPwaGeMBfZNoz+3qfXc2EFzEj0KejqzT165XM1uS3g2
1GR9MDN1Z48tm3y/2JfmMrx3VQ/5sIvrU4fmegeSuj05zkxKp5ju6jEGd86rDjNceac0DywO5M3c
AVyrOWlLXPdXfYsfYTvS1riNRtmRdMlT8UzDJtqhcFFHg5QlLLomVqUM157tyOiRSjE7eV7KQ08G
0K0arHvPMYddgcb2rgZ1QLkTTeciMpiK2aSCbl2vRDANZW+f2mkcSgPrAEEuHc+zgaaRpmcir7yk
YTpZELR3thrHP2DwG2cMtJ5kdtSnl3HeGljHM/ehwdzVhyZ2szAdNLrpqh67baKHV4BNDfhw/oqL
oyFmEEk3b+eO+RUEcfe27KmGSXdSDw5h3riS4NcEKanY9DiE3rAeiG1pNtmBKSpnkVGIfWmpHbO+
vQ667q03HUIq6N8ecWZzNDBK4mInEoiIkVDfMg4YqxWNWGGTjMzODNprkMPg+YDv7o1gYfHP5/6Z
8zq6FqhyseuRZ0CnlyiSCqLZMc+Fp1/SKcHuQH95F8mmvYaqpi+Z6MpHOhuQ5Tjff+6Y4i9kyUyf
XDgJSC+QK+AXLOJ9PAGfqpJE7YwumY6C5vQwCn2OXPgCYeDFxqcVA8fdlfWuLYiokstCdOykSEWO
sAx2Dlp/XCLL2c5T8c1a9HvcUiLTQK7cLQCf4aGJ3fvZxMdIMgUYpln2VyS62qexM1j6PUoJItVo
8s3xHuN6QaqF88IMAsfGojwiRCjxBU0Bqjh2YB9kIP7rwbok12IhTggcqgU5fQuLrj7pwkQGJN3+
Zooh8tp+IQ607YJPcwysQWr3O7i36hbbdnGQnqAModL+2gzdQAK2oa+HYpqI5WmXnawa+ASdGR8t
ZlJ3Y9S9TBkY8MLY9gE1nevHZwdUw8bshxFkrD7xbFX3LrCDU9+7htgJd41d1lAP9hx6Io49eP7x
QHcKku1kIvSQ1W5KVXJsAePyZbvXkvSVU1D6ySUdUx/Bf2KfZjdvbs0+ymFbB2R9JwqvqVH2G6DE
TEXdhCpwxGDCXLnX9hv8G+NQQvpN0D+g/sUCVJNOFSfL1zx3vbOWg9gUVTFT95DVA0W/30VMbG+y
GnulURj5tUnzqmSD75JHmgDV3mL4EC5J45607i/hnJYXdB0hTZfOMe0qn+7PeKVB/oT+mBxlYsyn
DlHMbRalq+Azip996o1sp2u/QD+xCPymE87kuzlSsH/mguW0nof0MKn2VLKOqsl6GAGMkvmmn/pY
yX2C6/N1tKbruTexoPfqoKuKsYTj3k3myBOduIuyQxQJ0FhF1Lwpq0ogKnoigS1RWW2+9whh2/PX
zc/0D9rhM4FIS3GgCGmOtP3lSZmRgQctIM5+plYXFyb94bOHPRbMPOYg6yXHB7hI8sFw2sbfKCzm
L72L0W0x18ETbqlyh1V4h3XseYDawOTkkhZIGzKJ9OJNlTWXte1ilncdBCB4rO5w65GFM09FYd4k
NWXwXgYkU7tCcsCxlAhbIyLS1DLfrDit9lHQye+zXeKAgEe7paVZXSszth6jPnDOso84O2V2muEy
Mdy7qMVFl4PH3Sj6bPB6B3QaC7VAWJSDPsFdf2hwJYIIsLP5oWqshsdmEXe1Cz2jlaRSAeWK7EM5
2AUfEgHAvWNMfrGN0Q1d9dBdjvmA4GMTjEy5JkGPFA1sfTsZRf0s2N82VsPbiDxeU6T3ib0rW1Jq
O+H00ChtkhsnA7YGNVw4GrAc05kDWIuh+BkfjLxixhScCYq17ufKdO/XftEd3R33bGWtOs9ugXOt
qDygdakdHAroY3cDu9pjzfdGVqGz/Ei52mzJRwJ0NmbTPR6Tz61X5a+eb5HVNLag9TfCX28LidsC
3ATMuk2SVmwrfCIOK5CYP3fkyj+LHNsnygVBcvGiy6/YUxnHDb7P88Hh1F96JjlZax85YftqE9ep
c+7t2LgkUUydM+EMl3lmR8/RhEaJc5O5NWsTGxKY+OERklh9CLKW1F0amEeeRbxBAIZZpg04uBt0
cfPc7koPmvIXN62v6hofmDHraVel4CMuktyjw7RJ2J746jWqnY5uJ+FMgDX6fHw28aFmjG7IKUHD
USbv8FE43IRU03TeyBHtLnBsOjDZsU0Rd7kA+LkoI6yiWa9MIDs6YBTBiI3wXx5EqLO90M0DXfjl
WAQ9nN/EdfaxJj9h79FGuZ5HVX22G5I2MD+5rEyTrawblZtvTOPksPX82t6Dw7KuadVS/oP7psG+
2uNflSqST6NBuAApoIm1aY1M6G1hyuEcU9N0UW2Yu66Zuu9+FSTmPUHsNHVVuTzqnMyrMVs766jD
t6NjHoJaPQwEu2CGNEmsS66zYT1PBfdNzyQT5+A2WapHoi0/B/oLHJbminyMo5+gwkVh3WXbbnIu
WBvDwizA4+F7dDFqN9VC/5fR78GnG0pfLzuPzCKg/EeXc8ZA2otdzrz9BV8YR6DlIsJJ7rSl5n1m
zvXeW8YuJGw39PFL4hFzCEisbl2jYoKBwgtPznXc1Pt+Wlgm+8k+Yiu9nyamYUp7Ky9tQWOlvQ1Q
gtcyCKpt7rFVpGuQBTIxQafiiOYHXHNyYQxND0CIwMaC/wXQ5EKmyycLQIpjiEOaBJw9DCRGZRqN
WIwS+SA5Be6yZLoh8hLYUID7lXdkO+Srube5Ts3+eiAJjM2mfQ+q6nbhJBFaVPOEvzmhHvqT5WZX
xeD6W9Ks6JsnoWqm/KhnU95iebkQRT9sI6t5FWbxZvv+jTtb9Ce9a/Km1daP5budoWXoHd+5z9My
vitnpGTl9BUSwhg2rKT1yN1ubHkom37ZKQwWW8gyyblga4KUFGD9qzjxdsJLL1LXESEnd0DyIMgh
GPWI4AJ8hBypIBhXY4ObWRWEJEL5RkhMrzpFQxHbXxeXxntuXOVVdlfadF+0poKNGFFvUgr6MI7N
EoAmijiieJ65P8d5SC6Etp/tIGmS0HGUvNAsIQcqvog9hdlTNk3plT/q8ZkXIdgEogIM3gKaxVk+
Md3ovBEhpXIdALjE6gE092Ne5dm+4fwqNE3nmZkPTdrA2pA/ZMfQ7IR57VDY0PEVATT8OkNgsRKJ
RR99MRpiINb+BPCp4XPv9Pb7un6FvUnYZMT8RZ/zxgg4Ty3UYbf48nV3FTEWm2gr0pg6aQfpKPuJ
5Tk3sJZqyjedJg9ObgYzxV3vlbiYMfy25xYdXnzJhIjYhtgdzPee9XTzr64kEsbv+/QIjqAuXi2r
GvaRq7rm5ffilP94VX5SA/kBzkcQhkD5efuCD4L9LFeBrs0EQCPKtbvCKbr7USgOTybHiQmt6io2
FwIP1CbtezrQClHAatQKolfYkdYN8gXHIE2hKORhIqRqvK+Yk0MqH+ljYBRPzWKn7WHKdkM5Ynlf
BYs94oRJXdpexT8yO/SVentAMBJHWuwafn3rL7fA/2nV/ge12A+/+C9atat6+VK+par//qNW7T9/
6S+tmmPitZKWjamK9gC5NzwAf2nVbFK08dIgR3Eg1lHn8Sf/dVqtAGBnFTMFEG9we8C7/1+xmmF5
//ZX4xzoX9tB7OX8IwDwz4YS/hnofCYGSBszK+4h64O31MQtYHCQoxlkCmMTG7V7WfZ+dsdIE+Hm
D7fmb0RqP8u0/roWogKsrA4GRVN8eBfyQQZDWyDL9IMhGsJI+xT9MdXF17aOBnq+efwnv8zPpqj/
XBKhhxBEzdNXtNb7+KPVkBNqmWUWEROGx+F6sGdjVwFe/YOF5W++mI/jas0XZHkDP/jzVQppg7ta
Kf9JHFTJSbrCCz2k7v0+sSoafSPcmT/hSv/mh8OFB2cTpR3CP+vDNWnXNNLt5EhJMNNlcmZmU0Wy
ZMOmk318+Me/HBfDccRxiZu4PsQ/3sYsQvBr5ejRhrZqGHwG7jenpihRbOXgAXQQ/OFRWX+X/79s
+pgWIEB5eAkhXEven1Xv+INFlAfSHGryNDbDSLJQO79hqW8uOMF+ajM3uCwr7yKBo/L7b/nxYVkv
ijaUKzpcEwHpzxdNugjL8ZRxKsnW0PGS6VVb1MUfHpZfr+KbaEzRroLctsRHZPJABjAuEuKzFCfO
61Q26ZVq5dvvv8rHpwMfoCdXPauFlxPB/ofnHlqPvzQaMUTjCv0UjDniDXoXp1b05fEfXwoKMC80
PTH31+9DwzlLUHFBNYrh+3OMq+knpPY8vthjQiX0+6utT9rPD4ZPj8b1TcuVDovIhwdjTOEp1C0V
qpGBwM+COXpOmqF/psEdE3YyJ+RwAKb4g+nx4wvO7cRQvVrSLW6q89ENh+pDqcbn6F6IteccLdNF
RhF6CeYCiNB6FPzD8/83DwkFouXy8wkc/+765z88/1PmK98sabGnkfJ3BJFTPct5+sNr/fdXWW22
rI9MST+81oUtkM3noK96lDebLhPxdmytf4YvWN9l1g6BJHiNrWOvs37+LiQ3yQS2zbIZOW0c6tw1
riOVyrNFbsk7vAb1By30r2uHT74n1RZbq80x4MO9IyPQK+tGrQYnaIDwRtZ4Z7WBA/vSlOIm82E8
d1qcf/9g/s0bBwJ9pdnSDGUj+PDG0TtmBgQzbeN3s9zp3q33NS7aY0Ts8NPvL/XLz7auUYjQgOUB
eDfl+lF+eDiU1xioWmdng6uyZXoSZ4eqUtk/fQR9YBM0G32JAAc49YfbuBhYThzBQDwn5p5kGRwq
2wbz3cM//DLrKmXShnfWHRoa6c9fJlMMSZBH0nAjGXfjjYHPDm39iYvwyy0LKDzWgIN1g/bkR/I1
lPpO5k5jcYzJjK1FbkvY1pXc/v67/PIM8MZCLzTddSVc7Qc/f5fZFRbdl5IfxvGNs86X5Ra3wBRm
HIr3v7/Ur19ovdTqkqegQp32we2Ncz1Fu4A6QruJTWB6SVf/NDeptHa/v9C6oP604HJ+oWDB+Mzh
xaYU/fk76QFIUWctctM3XiRY0+dOHlOEPEZoIRwEiYWYew49haIcM+yUk4E+YuD5x98XExFvFhoW
YI+QGH/+GLyvdhankqTJaZji8xw1gXmwkN7Wf/i+v/6GniXFunpQqHKdD+8xI8Iy1uSIgzCrq32C
VGuz9Et/RFpoPf7+1v76G5I64Tlg+iAeUDd+WH6RtLuA3iZgbkDLbiTax2Od05n4x1dxAodDxspV
YK1fv/APq8Vcxd5oFzMsOr9CR5zbLUIFgsJ+f5VAfLxxUHGQZa+QTLpylvyIOXDTLFsGOULHwig7
7Qr2r3Znjon6Jv0u0q9Gm64uBqmoT7dd2kSepHUUOfEhbgkdffA0POK9xQiH5ZOZJUmg1mSIrRWV
uXmZEkX0TbqD3VRMS3P9PYqKmjjCyGnLzZy2pn4gfXCQhPZUpt6RazIBcRaxyPXZnCJCkzZtQnpe
em4D1C7RZhbD7GJ1rhPSeXAQ9/Hsn5SVBekdfSbajmOLuMXesp+p4Y752EzjkT92dktV9eJOAnQk
cKHBIrBhzBEEIcDoWR5I9tbJRZ+1zScXPcrBrgc4Zopv19ygGzbka8Lwpbgy25J+FVYiiU4d+hWq
kBkF/jFP6b/cLoFbz6epxSh8Z0QOAeyiNabpknp7ZmhfyX5iaDNmTQASdyyBrMEtjdhT0T/LXYfQ
372v2ylK9sQJ+E5o45B27nKk0CmpbZG6A/BEY8ZJgQkwAWqxA+ctxdWmJ4GD1Cq3taoXK45itCtw
puwnyzOTJQ6xBKfFlyJxvGTX+LAa6d3bdOvx5CD+ZeqiuqN2BllS3dZQG7U3xp9zhF0xJtjJyrfl
JNInE+nVcvKDxrC2SGwc8FSWrtNbOSfeE47iYj6SplWMp0FL+31phwlxvt0sTFQKRMr8asOs9bbF
zQC6DJfDHZFRsg5LmZQCEcwqkSlK/vW7xBjwDxqlN2I0hPVGk7LwkD54mBG66zwxveDMkAHTB2IM
73F2/BbxV+tUbsRiVo5BucMVTXTtdjaLuGPIPKFle/MznNE2PXNzaq915pT6YkyBcO0aA6Pxt7Sc
l5O2Z59w6qZogWkiVCE2lrW6ZnCSepa9xwra6YemQ7H7NmPAt+2Q2ZGPqsa1m85ujznxnRb45Kg2
IZFWpYrlsIsJE0QfbKnYHL4FNpagS8i0Rfu9J7SnoSuad8ES78n2E9dm6dN+JLMswcvPIEwd+RDt
1xwRsXuIArJ3iW5R7/DXWsYlddoZF/GIwJOxVwtH/FYJQ3QIiVpURF+XLMr4VXuYacYpmBZveDPH
Eh8J1pOi21rBqhwzcoSHzLEzGFFBpjM8kqjkfXTGHnHXmiaXZGLHyP1uKmyJiZeA6OAKeU7THuCA
19+I/+mGQwIexfxatnbihD7UgAvCjM35spjogu1HH8/rySY73NzNKxNvW6Avuu5GO44vpt7vinu/
qD1nrzEUEA9nKGXthJ2Ql7ispvkNyXTMR0WUD82OIGUS1lbSoH9IsoghGyspO9jUN9wGYw4WSpI6
8m6mfBSf5qI2CSHjn3R2DgmhECdkkuQ7wBBDfezI6IvDzkaUEzot6t/Qz4ix3kStzL8vnUwpgBNE
Sms31BFHtx+r8dXNHaaLCSee4EiWdIlsuAUsf9ujmPaeuy5LYM8VgdufPL/wl0PXQh/d8Nxrdx9U
XfCsgCJemU1gxDuryOrvJrSD+Cpp1Myr2UHY3eVRU6M1jB2/eFDaR9limDXp8UHWj18cXOur5LhO
HusxK4Kw0kwOMF1b1XU+VQhae+Gn81GS90vgeEsUELNxDvzHMUeyvUWODv0Cbrt+qaWBNsuYi/Ku
JfIccMFUGNf5vNposCZaUC58Iz7Y1sCqgVAAcU1SNvkjIdWNCKGOY1mIpwjV+OL7WUNeJNxIfr/O
Q86baheiHsHk/q5xsyYNuwquxN4RKBTDmhF49BJT1XB0r1UCBz/oGJuLMUhPNesF4HJBOCnhq/AF
X7u4Z+xb9Uvw6mH5ASriQ0d9R5WfYDEXououJHyFAT1+MlpbBbbLuPSQLeqtXxWFd2a82LqAskzS
DdjEgYSbHZamnWOBQdybwyCWbRJ1kqEMXEesAgFeww1Ks245J7wtYq8NpvkEHlVTd8awhBN78hq3
3PmrBIyZrxmVDG6KzHrq8Gkn20k6cXA22crnzbR6SzYTTSFqFG8O1N6uaNzscquRbyxryrxi3AWl
OXYdFfKyNOaeREMieROmOvLzABokCCejJFtpRhyO/zER4FiJzaUp0cwL32QkWrTeNnjQstAdanfZ
BdqJX+YIvBiT4TE3EVIOBGcvDc6W0BhHfCXxhA08ZI5OUdgEHmhmQ0cYjFIIskybK48aH/ztkYxW
ja5/TvDM1HiZ4j3ReM7ndNbjQyZSh+63gdQmxBhj3DRGRFPbarIB2xU5YARaZQOzrSK3DIT3gZEy
mlg18QRRQx9l6DYhjaTVmL1b6BbKsMN2IMO2L+c3v0EQz7TCHv0dDreetd3DegjBV7TrHEogOrBI
RSyOJjMcEB4WVsF6IEcp7C30heifhoDoaNTXz35X4Q1g6mj0uzYR4HoRs0YerOp0vqPrN1eh1zaE
QmjLQHZYE4d90RHI5Yee1zqf5DJgZi9bwcG0jbHMbu2hB6pQ5tFI7FlTd3fJsuSSz5O4NPVz6A3M
Isk5wIm/BiBIHCLIrcecEyejhPrFYuvjlSeTGSel0liIRlfZ3xKJ/hCNuk1bqx3Ia9pAx1BoPJH6
G8Bf2Qy22scuFqZLXn1hwIngqLFr8Tj4wWrFKix11iZg8xAdHVY9r8rkTsZDK6/tFm73nt7C5FMg
FSqkSRJHwaZ3AbbvGkan2d6CDqtu48hU8c2cFA2myNiHTrzR2TCMF7BBFntnsL6TomtWdXKV58Vk
gU1hNv5gLeXghrXvuNm1kznLcCCaK5uOC6A9YATJ7ImLCEhwfoHs2VhFsoGFNjtOnSg9e0R3NhIi
Z+tANq9ddIrLnjQH3znV4Ei7+NKygUh81SOlAvurpSSYCs1GijkaTpEDXcFgav2ZssWqkX63LXZu
RJYRljbCw1M2xBYpZ+y5xzQ2wOM0RQmMJ+ZwyKAQCRpWg7oaSKziJPiC4xT8ti58gEIVShi6wrWc
72CAqwC1HR6cDUCgFBVX5PUzgWiw97c0fnSzpeiyiUhBMMHtV9yCHb+Me+5au20PvdMVd6ZREyyM
uXl5Blq7+kBi1attjF3vXkP1OLu4kNPQYoW6hAzuZGFMCl0XMkA02KHQFOrdiKx2eCGjwX6ZOdvy
uFkkt+2Jgq9I4mY0R6JFiuoLyHtAVoJ0uo1N+Pc3ev0eqMiJwXs4I3u/XYV2zKT55KTVAPtcvdCV
cW1qU+INaKuIj1fPtMgHegrxrhVp9oK4ghXEMBChb3qbInEDUgHATymy/otmUx/DXhkWrgOrXL2U
RTQ+q8wHEUNQ6cj4XDTeYwu2sthVQuA0AdPewcSuyxQs7hLrYTdbvmYaWooC9C1gkkfXsACOzAOm
8T1ln7z1zNjDWFcUUxzaBFW/WBa5OWvwxERozmpy8ao1fUcXDGdQ707+vQBYXG6dMiuw25sxcmRE
a8P3olu1NTGKHYtHJmuxdhOdzf9jy+5Ti+f8a51rWqaLT4r8ljPb+F75c/PsQfw5OlFELWXmgtMS
ZwFG8rGRY2mXmnfVxc637jcdsV1lRhMUobdsyg0c3vrLaHQSVJMzlTsrzgoPM4Wb3E6sdM1TkGrF
KD+RLY8SgehyC+QfZSDTS2SgCRybPaSnsgpl5Y49aMYKq/dgKXa9fM6Wu77KoF0FbKaXcpU7npOs
Mp6UF0vzqfGtaGQSnQ83i3Ls26ntTfL8EgfhaRYk5DCZg7cPEvJnlDk4KLjdNUoNCVn95lRxfTv0
HBkpsfOCw7CFhzx0+gRQdSkqkDpsB1F0sJw+m06Zx0Hjjp7H+D1WVfVeNIBlt6XRsnumbk76QCCm
6ssEIBMrq+noqQVqPswiCvPYxVO+kXO1oIvEj8oyzeNTZ+2FZLUJXg2UxfouR2IATqVL8h5hceqb
+RMO8gq2a2PNMbFzga2t7gZrYcFbSab2yq+mAOJPpBnJT6WelqdR8nrtigJ72b7HKUmMU+e6L3Gb
DY8OR0FMHZxC7a1AHggsqM/mLoRM5fv72RDDxYQialo1jRxDeFtTHjqz9xKgXJbTJd8RLrdYN2p/
+YI4rf+WqS4ZwhqRc8VzagAobwwF9crGHovhVOXVhQtbKdmXRDh2IZEUXrQrNCKz3VJa9qc6tc1P
Q8bqzWJbmOUhkEWP/rYiH1nhlruuEEAS02M0KD0klfq3uI/q4EBQXv7SuIVN6kVXFfu8cVI79KwF
e+zUG80tBl7QSxsb2mvz1qcc5B6LkiHZZ+4t+MDcGNWM1JnSe4MGwntKIFqTlDQwBAUALrt0G9nl
MOxjB3nnRSl799HxEOcckMZTi7FOqy64M2hnZBeVhGSK/AzUzs4aWlBjVqm+itl1WNu8jGJFwoBA
kSBg1u5oNlGQk7cF8kqrhpPC0E7u0YWe6m1Ir8Dsa6D0f1wWoyftPGjtTZ2b4sWfXe+KmbrAl5F2
bBXp6A2fMCab5N1rU7k7njhqB9qnsJ58AE015O4V9E17uOkwImdxcVAtcJuNRyLV1zIYFlY+prQI
r1zUumHfyfZsV+RF4YsPwBFRgML3G/u6/0IIhU4vR7cWyDZmX+oD488o2lBq9Pe6LdOabdqfrivR
lsHOqhXaYL2o6X7pIJYdlgqPGadnw0ix29Ep5dHzJWSLZfSOErT/QC+CxvPGhU+lcO+lAWW3X3jy
cihF/FJpv462qbeqRqRbWo9Q0cuKNZRiF829t9Zu2A0uUoQreEAWI/tEyQdAoEnYQ0Mdubz8apSw
07RTkTLhdqKEG+0HvQwHXAFf8dDDyocPiiYqg3dcHCb26mbLc8lyWE8EYZFPUgbxtogzgt/zPi0+
q5FlBhSgQ5m9mEvxZCif1NAsnr7rEjoHpWmqcYI2w/CN5zLG1QUkJn1f5rxSB5Pa2DhHIu0EIucl
YT4Nw7k4+hqgwMHH5p6GSvi9vefUi1CzLJ0lJxoObcdOm93yNqmUdacvE3FbRCv+ieRv/QpTUVM0
Dan29cZGY2zgE5z9ySofyEVzeL9UP2eHsaEk6a/Nxp+x8qJyA1W0cFL9SuMgKz+bmTeIMNai7Q5t
3NCmQjjJWf0REalSbHyj5RkvhWOif2GoKJ1sEzVox7EsumbR3hd24Qah600MXFQ+ps2VH3nj+zjl
BJHN1YS9j8Wb07LMOa+k0ksv88WPvrtqKN8pbvtXlGmJ9TxETV+8ZxPVN5pVSuiN8GqLtOq2yeoH
CGaNQoXsI871OobVdAFU9tzF3X2Vz77mEIHhERM5zq4KE62dGQRrB26yjRocm9znz4R9XqpK31S1
g4KrybdJI79VhTW9ZoGPztCPg4Mnx3O7lpxGIw5+iU4mF6PlfI19B+/nvxpepSiv1qxzbYhqO0B0
vTVIFEE8b2U9m2Tj0DPMjLZ7pS0BiW6WtGAPVju6N//y6ynSmuMfB3Ssh8glM6IjOp31N0FviwdO
ZqDSyeShPJ1Hv71tgnrFJZDz/fT7XuovnVQk8ExE0HVCv7Zd80NfuAoGlycT7WTK3Q4jWpTh1ETE
aZrwxX5/qY8taA6GzF2YITGig9/zERrrTvbULQCwNgLb/1XMNghaZZ7+4cibqzASMRl5MxZBHPOh
ed9ifurqhGiHHk3YmUNQdYmwxf7DVf4js/hxVMFloD/RSmcyZjvWmkX1Y6e7jTvtWB3wr2A0imiP
dZVCPBqcSu1km8/Xaef416M0OVPksTKefDa8d9OzKX1+f1f/7gcUsKZssQ48Hfnhgwxu5AhjFb9S
KPfh2CGdNUwsL5Uy/juu+D/l1f8wEfnhrv+ivLpO4+/6J9HV+t//JboSKwYMvPiKKbZ8KVaVwF+i
K/PfPH6wmKlz1sBxGxLY/6quLLLaBbNOhmorNVOumdH/JYQJ8W/G/8j3kEsx5YAB/I8IYe7PDwjP
BawxEx0DGBtgXSSw//ykUorPaazqXRQX1nBRZktth7RKUT+PwFi/IcGhW4WpyZRHo4EuENat6syz
XdaRcbCZtdPHzocZPKoRDMU5or5yvmH7SNXt6NuctbJkyQ9RhigYfayKnouGHhdNpqn66tJvfWtR
GFwFXSV8TusYOmhWKPvcm7qO30ZLNPGlYYnl7FtwI1jNI9Imo0FeYLoxCR5hz55oIJakUcPGMuE7
nGgcNPoKFszQHl3gbmRNaA+0Ah0gQH1ZpZbd0iZMQtwYC8T7vGCbu/SoyzdWnmfN0c88mTFSCGS8
m7zMoAuSMWYwDzMyF71ZyS3m94rut6r2dJwHB0BmX/uSDX+sAucIp7Wzd10WTRFESGsmasadbfva
q1m7Q1L/6FpisEaUvlkG/f/YO48luZFty/5K25ujDMKhzPr1IHSkiNSKExhTEFo6HOqP3nf0j/VC
stouM4o3s9njdwdll5WVjADgcHHO3mtTgcS+Fbwq9lQPdTr2iFrHgCCuET3mRnVdh/zf8bprMDG4
WfR6pAOgs828TJW0oX2xuT0rS8HhaDBr0PkVGSnBqtV1QoA4ThurJqnM6wpd+wZMkAA8pgcULUf8
34ZmwSpC3npoR83TlxYu1peyEykC36GIbnxZWYt8SH19Fkx0xDbayTekviQr9uja45VRxnkAmqZp
9kGt1YTk+CanhWjUHRbVMgDZAuGtWsVEuBgrkYDi6vtWLmFYXEgz6tcAwIZtDKKFc5+J+7YS1Ysg
MSldNOykjEVqFI8j6/Vu4v0qaNm40/2U5fYr+FLfwJeFMRRmhE413hKhoYjXAstDnJ15k1uq01Hb
4Q4NdtA5uVecANp0hXAiLG8hUACqtWnVs6mumyE9y0MstmeFaD14Lsp2RivYTqEjre90t6EPLZBB
yumAvzodN03bckRpYocHq5mTQbyKJJl7o0tR3k6jnZyKuvFXsNnOunI4n/z2hyppGPoV+29sPdki
yuJ92GXjstCwPjWxrVZ67bfrwVNnmeyxP0VZ8ZzYzS0numbtIadeqUqn8TS43gtRvMRMDSj6kRHA
bGOvDOqHDUljD9vQrKhoR1lHyP1ABTTS7ttMv08FbhUc5ZS157S8bKyyrV4rYmr9ldFT72m55t2Y
VWxD3PtAt9ZlAZ3Hc3GqmLaP+gJwiaZjq0gn/VUOxeM0Os+1k50SKbGeBlKJRC+8tykTrxrFfWRR
lxxkzZuCestS4K1dxKQtLIYAHxDnnJU1UuAfkyhbZb37SuGNEyKF3QUk0xB+ub5KbfZynjI4y2PQ
iAJNUmGHlTO1ffzc8bxPh4C9WB6e+RK6HXVG86Eow4e2DE98P/yGwvymn5t6PVtz324JhxK5t+o0
dajcJHyqovzKNL09WkVrR4xPs8QqfTK5JBy3lXYRRui6guzhPaMoD2HrUSOZC8h6cJcauXMtq+oO
09qTlrcXgK9pVrSnOqeqnV2q8wGT2B2zek11vS1/OAnuzbInAo6OKJPF4A4j5wDnOuk542e4j9Z0
hlDRhxS2MzwAFHeEuabwCLIjLmwJjQlrfOV0OIsHooebKos3Hu7ARWGqaof985sVY9xNbOeVrmB6
XqPtOxR+cxkWOPCMjhKTETj+mWw67ohrZgvMsN5BL5xmWSmbQ5vxkPX6JiktUkgjkV4Rd7ZDtEp5
rbT3UvcJWgqeIkc8F35N9l9CxSgTw0M7BC3zRBNswkm3144lo3NYtUtyKoM1JvdkF3ZU0OhKrlRT
s+2qJK2O2DqHqNCchrS6T5RL9Q9IbrV20u7US+WNq9jXaglTSEVgtnKnF0j81zm75BOny5pt7/aP
WRbmN01pDcusH0hJ06l9xa1p7oyg3ZlGNxy8JrNWMLKpsuj6iviqMywr65ba7FqmWvIU99aWfsJz
3itx2/XiIpuDfFt6DsCb8nVSG2DMothbRS0+OLtv7uSgXnOnpDocnxYVtdZ6VPd5aT1Jj5I6k412
GNBdEeWV4QnSqiucJwP75+EOl9Gw0YVxogPAIh6M4ycmSxWYdLPoVuCyXUS8UTSW4UQIsU2VUe4c
EDJt2YGNAWNV2v4qGzVGZ61RqepeyY89GcP6YBn1nrQwbd8V4or5LT+4E9fcejCTk5gShm1Xr5yx
7my9+GHK8cQR0Xpk07kayvKMYqq/bQiF2EyFdgW0GKOv3/CuD9o+r8VJ1cn2OerIawkA/6GqJMYQ
E8tS0AahpFm/lOV4CYiuhF7TvkR6PDLj+9mpaGINCU6NE1Kam1QPryesoStXOqu88181II0tFLur
MrFPnN49nwwyhRuA915e7Fja05j4MpM00BdkjW39A59Wetti2gRYAJ4JjlDS6TwBHxAzxugpyRYl
NcTyZTCGloNk5Fpy6UftZNyLKCdBmRApqhURAuIq3sgS9gQ4NMrp2KRbXMHFejJyNIjkdVpANv3J
i+d1rKff6d56iujjszYHi2n6Rq7ZmPSUHTtXppeXtL50jRWn/GEauNXyfU2smTmtVQbVnA4VxTZj
GUecalYJX1ayc+KoZ57GRh9O34Ret4O7DhDtecZ20FM/M7dWofV2sg2s0hyKraTMqtGZlsWO/ldn
3vHwzLI7jKGmn+gUZy5x6Q9XUsb6c63zHq0q1gqTGkoHGP6mcW2yBXeuBggaO05nbTAdTqH9kMJb
cyi+pwOH4kIwhq4yk/cQBo9m9XoLg7AM6Taw8toUT6ckT3Ce66IK80cSVqFoemV5pxt5n8E305tY
GntFNPPTUGR9h4k8ab3lxMJnmzhUQa8obD/DWYIOg9husLSRuMaSQCUntvOBRG3c/AnpgvTiMF5S
gNkCpprSaIm8MlOrDF7fCBdcVzXCPCOzcUTRM3GR7yMsKbB4BRzWjTX+OTQ3dpqDXpRe5jIvpBML
zSHiYC0vZaBDCsSe7ntXY47hemnJOt8OLaXqJTmbMn4qjOZby0IQ3xmhLN2bwYDQsfdMQaE4FgzU
NVuoy0ZTCevJhOCl2UBCoN8tNatcEWnZ0evroWtGc6MMv1PRbWUHoJWpAPkGVYnGDtRb1+tjfNmn
3tA+tiV08z3uoiFYRZTLwE4O3HTAdHC/tTKjBujRSXU2ndT65GLyZi3VOm4az920wNGgjKIm3EL8
w1aduF0yPNBLktdBboekKUkHMIYDvMtcxJ1fw/vpBkQgcTbG/bYAdlSBtE5aCn6Z5uwCP6vdbRTo
ic7rLQhTYcucr7Uc9zUUNp9aWxf46RLGzByq3sR5vqosn5AODA4EyctFTWO9pg1BhTAaL5oxLJBE
0bzJ9kZVmOI+6imCohxqyJ+poOn768GNIOH2cefhyraAfPclZqR6nNqWhDyneTQ8i34KRVrATWl2
kremRCA0tttmqKYHM7CqJ9gddLBYsLIGjssgbXPbp0lQLAItlPSvcrWyogEoSiJt0Ditdjb4brkn
s02cpZ3qdxjN+r0GfeS6zJjtbOA39kJKosa43SfONLln0+CZO5eGxonuMW1xldraj2jcUmqPMZgG
Mt1BfGAdm8IU3BOuJzfI5MYiwvBWZngipe6BhCsrcY6MKvtOIoE6QWCR3CeDq59pKmx+FCNWz4XL
Hv8tC3TnR1ORFbJAYo/mR9FcJ53erA6DkyVrI5+1EF4KgSj0amNjlJ5i34MFN3JzoOG+7b14cVqB
MBsCOAxBc+VY7LMyI39mWXmucPksiOsOlhrUHtQ2TvrMkRVdVQOEoy7TZDcMJRIYyVK5b2IQAnY0
PuPQwQCXEiptN9DjliipCKJQ+L/ikHlRA4i5px6mb8a68+hbF4+sOsTaE9r7KKDvQbqCp59XQXRf
6TjQvKw99ZVsVxZd6AWZgJxOXNBgxNUy3SyKzuoefBmQ6jzG7iriBEUcuyN2Q92+Sa8ONxJR01Xf
15d50eVnYcyon3rLXaYeS3k6ZchGcjflPJb74Ib6WtwNsboLehHtE11oay93NgLoKLexc9ZhpRsn
0HiwE8C2fMH7zTnWzcvzvDCQ2ykjWWFpRslCSXRh9qB7e9FVD1wJO1R4bt22zLuRg2Ti7N3AmA59
Lqu9ChqXC+8G5CcjjabYbdOfNZ//LsRQiKE88e/jxt4LMfH3j6UYfuPvUoz4i7gkdKcWJFC0ynMx
82cpxuQHHv8WZbYQ6L4Nyi1/+98M6y/Sv2bxPlVJ8hZnMf3flRjxF4VEkyUCbJyBWYff+r9x9n87
0OTRnz+kOb772/5VM8SQh2ULe4XD5xk6ddejWisgBJMTcsBRIImrYTviSYc5Zpa6v58yffQ4soQI
KIYuTiPwAm7Li9LSOttzyPNoRFfObJA2nebWVUXMXJf2YX/hlzZGec2Oa5h4IXZ176RqQcyiuDRN
MyOnmtwcun+Sc+2iJtIl3qSm2yQ7dxSJvaz0pHTOBfQffQnVESlsiBPaQbohaQH6RkRFHWlsCcMN
2wXCjqxM24Wix38u7Ej7NmmxM+Ol2JqzB3XHcyE5l6VJjIbLys2xWyJIrIxFmQv6tqJPmfBTPM4V
OXxADhfUIvJpmQQm84vVJz5CG2eATBslLjjHNoaLt4EsxvnT0eNqJk+kzrgThcgefTc1DyISJdGp
QD4vmgk+WmR4NqDG1nutAtOHpzDatOgjGpBwBJQynEdg0H3+EBp1y5yKuzc/J2jdz0/6bibJFSVL
/UrNJqS9IJWwvLFwBrerqZp6c526ky+XLvuRaa13RJgvElt592UpqdrbJR6kcxoP6sx3Am/g6WkZ
O6NYqukkq4NaXkg2JrjPE7SDHPTM9NR0qIovStkPj0UYeIq53IvoSnVDEdxTx+7EBnh0lO9kEOFZ
D4G2W2uYafVzQ66bsZhqz32JMN9GS90cxX2f2+0Thn/NXoMEbreKwnO9jKrCe0HdWTbsTqErb5nq
7H7Jrg7vPa5B+mIeaain5Iprc7dFjfamoUo2LlNAdtlCh3xN2orKmWsHg6+1taUzECVL53cHrlJ7
jTot5uDfx/GpEcg5SDuWPzCU3rVEBKWLSCK1X2atV4GiSLz4RvWUHrhBJH5lmTFYpB01jbZwJtN6
MMshpTIkYCzRQbftayUIuV50idKR9kaEki26DMUqRwcsRIsWYO/jgOSLnJhaFS8mUB163hbtPqKs
7OmqzhA9wOYygKOZVonXNCs6DvMoT5q3yMyDlwCd2wXOSuM51jlkbHzsoRBKFJYIWo28Mws3c91u
Ww2Gux6LOohXSVLncDpI4iaPHXXsgvTp6bvQ7Oqig+BP64yaE0rnrvSgbNGN9BdeVOOyiohaAgve
NojjY90E9x7akh6XHvSo+8C1E/yWYZ9+yXuCKbYoOE1a6h4CI8ZvXsmbIjRFtHIDH7Vx15rppZHY
5nUwVukZjCNKIFGT6q81lKlpwzI9QLTrEu8xsUPnCoyZj3rSzdjcVYaLZBF2XrmP0CVd1By4AENm
tOh479wEgWrrhW8cJqGj2Q0mMX7YI8eRtYdJx7bmY2IwDNldH4UgCcnwxn6UlFn4pJL5IUGDi8VC
a/TGWaVq6hI60qH95PZY+Be9UQePkeXVzFNGWJ/7XpLf6SafCMQpGe+nsbeiiy6fOQ+G46j0uhlE
QxCfrjkpXNgp3AkzIuti9la06xD+ZwauuydsS9UlJVSLxG7eLNTw1E+gHZFqHeQ81VTh3Vlo9Nkq
ZCmDyIk8aKtpQ+xPpOjEpfMV+mQNrTRRdhyMsi4+l+h3xKLEYc3GYPKqYOU1VuBsRvQpT5rulk+5
qE0wur1WIdQguG9Oro1xy2QKVD3/DFt67hyMLzKQC88SQfZpNYQTfBDfLmAfjdVQraQjrOvAHydj
7QymAGs0RQ42ekAYJQCKqGhWFW9esbAsKmTLQCirWI6Ol/Rr162q6CKI9Igdm4JBCRIzvI7rvCOg
KZjUpjBrJudasAB5I3kLizysZX4eTE5RnhInlaCjB96BtJRliGDqyU7yDfuq1l87QV6QkFkzMFQc
QqxugfNeE5YUYHxDpwFljpQCyDHmED/FsQ4UoJEIzNHHGPGtEE4rQSda5UmQm4Zcp/RDUYWJiqIS
0yq8LxYPNfPvTBsaH7U2SqAGpC367iUlwxLk4X0so6BYua2ORLHmH6hUBr26N+PSR1uo0jm0KtaL
aEnEvP0UIakJl1nJi9o4yRStMcBi1zRcV7wOfkxkF8t98uTZFMuLveil3ff3AXlcZrNwosZ47Vsy
NtQ0xemC5oS7R9SWd9uADLq5MZ0d7MGx70wtnp4yZTYvkcakuER667yi7CQfcoQpeE9qAptLSzbl
DxECOBsmtzyFYT19iw1TnftIXKG7BvD/wVEnTbniQEBVLa5L43qkqPGASINTcu6WJEz0/PZjUFtg
pwhFnSCDaNOPVGs74PpMBZSqRbvtswTQW4T7/UKYeczOVsfmtOhwQ0YLcg9LLNtRZ+xt5TJmwObN
0Htemhhrd9+hlY475zal5ECps5ljjrJAtOQCAixVKzE0PWJaO9XPo6zGST9oUNkGAuHE0s44qhLZ
NRfK5XvRnIIGBXQtBJMJ/uZngV2kXWx9p93QRvzi1FLfpXCfD5fTlNsU5U2nV95Z6BuArAGvdRgZ
mESD4tbJcMCAgE0EYyB1h2CnUiaWfuGTi4AyAD6eftUg9DIQCzZZvkL/986FgWjjceTJTgvAnM3C
nRLjxfXCvn81RupqZ4CI4ZkxC9PmQPxOy2Ps08CCKGORRZ2NkfUcZohRl5Y+5gC7DUcEKGveWzDT
0OrBXqpRRQ/O1KIFkhoZTrft2BUllYyEuigajZBukMNMbyzz9zaR/94yirCaBABJhLRwLs1tpfJn
j6n72XEqf/afmvdmVA3cH+GOR3d9S+bo3LHqfBrdPRC2XHhnkGGD8UfrU1k6SCYI8ueAczXn5I6V
zXnw3jWL/BS23zpnk0FDbXrvrkV9pdzTEDJTuBRTWKJTJactfC4bjd4GOjkS7YfEztslMle+qAlA
GFF1gCEFrBWAOfGqhlZlJ0RZ0yF0bR9X9lx00cCKzV3E4L2jqI+M3V1GA8nZ1O+tR4YpbUhrcmLj
XurYVLYwztgNM5Dt4c7rkoKem2331AdBKkAR9kELPmLKGMxt7qngh67ATGwLTBUjs0Q6UvQKdA6V
5sRgXrVdrhBa1ujedkXWpODYcA6q5aiTW7t0GkRsFwQb6NlplJjqTWMnfe4Rp/rNJYHE3RjemMYb
o5GSKp3X+eO6L6B+LyfXAExa2uCNVpQJYo+b1pWHyqMktB6VQcJO6dghDU0uLFu6moW3H2w+nKum
cutn5oRYbexOegx1Q49J07H6zrtooSjga/Iyq1wL9h812zYVUkcNTATyjuPpP2oLxBrdibhgIw4V
0Fo7ykRbXRZRClbbAPLMPqRrsy2bBDE3MQeKJMBrmfUq1s074cdkNvCq1rd0iOJoo+hi2qBdehL4
8sAYnHXlxsncR4x+wI9KoKR1WJcWLJHjaUthGPU4e+t2hZdVgCBqJI0uWTu9v2j83PFOjCjkFjeu
Hj1oBsyxpXJw6eNSaUDBFTYZf4jFUz26tFQTqn1B0g3MBbS85anoMzzFIzLMcjnB6aYG2pcV53ok
2zNeWKXFeT3M7Kcy82rzNPVLgg9Cq9Ei4D5uR0QdNhONuiVPgS6Dk9prshzwN9ICKDLaqXUULFvE
0XKRVGOhlhQeRxckeUSVXpd+/9JpU8Z2WkblW1jFGU4derTJc5XhTCDTA1qJsR5lXE2ryTEk8Ne6
dPGrUlltIX0vyq5VQ70A3loZ3Ybzh29nK9cOTVSVBQrCYD2OVkv6C7YA/85hEQ02KTpp/TpqxsC+
shtkjy0WiopbuhTE3sk7sjYSQijCpsrb6acY579LCP9hzJFd/76EQBJI8fYdPZOU39WHQsL8ez8L
CRpFAQehKKIOHf8AbV9qDD8rCZrh/IVuAwsiEg3+D8LFf5USKDN4ZKLpiDYMw7B+KSUA2fGxg7/n
lVNK+COMzlwm+FcZYY4w9qhKkGzvzoAICtIfBR1DjT0UAvBFyE4YM7RsafuhCNa3Ab/EXlFr7vSs
gbDzy236u57xa/3iSPL083M9CiUmoip2c++m3F/MvZTcyrqr4osoXAujPO9oWEZ5O/M9z0BevRHu
s5YBp3vfSh///KPRoWA+p4iC6f0fvuLArTPUKhfsHnA/Ro5S6wGU/oaipNEuaQJH4flo9HKfDVaD
XsFxenI80U6HX6itDJ7u8c0XOhUmz7QtCxv1/PNfbgJurNBBAHgxnxZMJnGH5CKJJBL++ES7euHJ
aab1OYXxjE9J4iHPOfgvDQI7KiYsLzo1ielrFzhzqvr/4wkhRRMMWAsTH6HlH79cBCbH6EwkOVUd
kdmQsieIEmVQdsk8jg6ia/K7cWiHcV3Q2YlWvg/3mzggFZx9/sDmDzoaokLg0eahzdQn48jYbo8e
WTVleKEzKJ5LW5XPQ+k7MO+G+ISatPHQ4QW41Py6vNcdksU+/3Rezn9+Omnx8x2wAAoc4YpyXaAC
lP4hCZvongNw+2xyNt2ErfkVq+ijpPH9lQAMAxeBlwJ45ozV+nU04EYe6kkLDgEBAXdEJ9Q7I1fG
9s8vx6Y8aQNNQat5zGfBEsfGLLAOYUA8XybC4W4IdRCQddveff5Jv7scIDA2KJiZ9TGL0n69nKwz
cXha6QVVMnVbS6e+wKBZ7z//kN89HVikzF8Uex0Kth8/RKU4J2QWXxRYFWFe2gQW6RxLr5OyHU8/
/6jfXQ/QWReB3cz7OH5Zy56YWRIQL0QzqXXXRgCY81CpPxO2/hwFyP8o6NoYIYHvfbyiFuo2Nf6Y
m5VOt0mOoE3O27TPr+WdsnH0TtlMJ4SGGpZgAmK1+vXh0GZtOnx4FwZ6bmJTYMySueHWXbERJODd
Flbe3vTmZMOSHlBIrIF959ihK9MgDLvTqeJ9/oV+c3NtYfF+ocnz8F0dXTXehdJGEnCQxLjsU3Qh
u05Lh/XnHzJf1PFFExSAhNKkcu+KI/RIRcp1E9TGwTSRl1A7VwtVFg9Rlj4PfvMFVec3F+SYLKe2
C1XFJXTo4w1mNwxL1B4ORG6Fe1QbJFVbof3VAvKbqRGxKOOEsocDYeRo+CdFhFAzMw/+2Jkn+VzL
wasR4SVBXFELnLpEOYm1Bpb4BZ+RvYGmG17bzqStG5FYZ3B2g70ZZ8FtXbfJjZmEHYHpSLaWlpYk
17byiy+mn/kLHT0CJnJGNUg7dNvm0SMQyqxqGgkHx8QiO2FRfeb4Uy2Akvsk1of6Tu91+/rzx/67
m/TrZx5NRG2kDyppxQFXPVXdqtXMZVkU42nlYT2MLOgwiyKbTc8G8XNnjnS0q8+/wO/GgmvB/dIN
GkeUED+OBVVRAWRmOZBXCtBAa+T5QJbJFwPud5sJXh1gJuSymLPN8+OnyNKocYDrB3YblrVWQ2mS
URYZAmnS5HePdk7yd5Vm9lPSF6SAmo7bNWAuvGItEpxjKyLqEH4rrI3pFy+38bsbwItHZ8xBPUz7
6+NXmwwT3gcSAsaytwqaMromxTx7psplrqe0ie8pRKGWk5LKN4v5XIC3jXUUd/GjoTnyShRl/UYB
tv9ibX/fZR4PR5/djc5qyEvkHQ2NbrL9Xvr6QcWJcYKcwEyWxJp2J7KTlFCIUrlRjSyfnGIoT5um
jx8s2eKGjGs5zv1wmEVO2Jj7oSrSkwKX2e2fDxzfsyyfMeMJVrmP982plNQ5PBy0xkbTgzZvkaSe
Ov/8Q34zK4KCge/pCZpu3vESGo5GSGWnO9BX61KYuSK6yzHvLOIpQBVVJIhMPv/A3+39wUyBbWNX
B9vSmxf1X7a91UQkgjDkgRCC9tRoU5NQ4doAIY6iyQfEIIZveuRTgxCxMezAEHU3wYR4/Ith+ZtR
yeto8sp4My7MPdrZpaSsWTQkDySgokeN1Q/dHLIvNg2/W2ixqHDOQbNsc5o8uta2IEkijeQhb0x7
ScmRrPZGNttgQGVdA/pfcdyQNTuJoIwXADFbbTmBrAYl1uhf3Pf5LTsa7HwVTnykbPs6/aePt71p
GxeFXUPOE6cHaudPmLLeek9/xhEJDmLaStf6aoH63T1marNYAHEMmO+355dHnaIVkXYJebPH36VV
DQq9RNhLYRC1i0xoL4qKrOjRPBuy6UGb50hLXSHRgWtPYtC85/h87P32+8yTEMMdn+Ax7G6iRQQ4
pDjAmmn2DO1i5QNT+uKq//khPs1I1rn3HYCYVQi/jm+tCBtkSvUhH8zojgaGvCXgy/njK/FJK8cr
xMzgARKwPn4I4WHwve3+QF+xebF6Jz2ZsCV/cSXzN/04ZPgQCLS8rSDbmBw+fkihEXxiO/2h1Xvz
pmqndh+Qmg0pq7OBOX3+aH4zGXMqsVzYsFwO89DR+BxR/qKtaQ5uFhcjGUQivIoGO7635DBM637w
hqVZJdYdjBG1Hzi6fB8NMzoROq1KE/rHSmuEQoCpay69cUsS4fvFN5xnhF9vBzfanllhc62Eefkf
M4ZtB8j8zUOJsNlatL2Cl6L7XXxq205cLD1pQ+u2fB/2oNNTxl047TjuEATa2R8+/fmbcERwfcie
uukf+3BSa4DHUI8HBw3Bkg1oSg0+1r94IsdPnw/BlEb7Cw8FOK9jZOlIF1+DOXMg8hDBSJ/05w5e
XzEWyeHzG3u8Q3v/oPnEy7bF4QAw//yXWYL6kwFPqT44eUOQDNFr5PYObBG2TQ/pn+DGS6z92lvr
1z69bkd/+vzj/7F1Ovp8/2gliN0wdMyyPcRCynPWi+KyNnt1qev9OcG+zroOx+guc2L0/uN0UoVl
t8EPa+xcYrexcpgaHMHPv9IXd+TY3jiMUwwaqDlQv6a9yLz6iiIwQ63myEWQuujdDGGv0xTPLySh
P53A5vth2hA0KTMaM33y4/NADwTdw5YHNzf6JWQ0E+mjnX8xtzj/fJlIXvVpL3o2Mqpj5mTQaXVD
/PmBp21cmUq6kMXAwQW2szZsL/3qGc+zx9G762HhZFZ252KBd/SMM43qv9/WByk98PMWHMpTMCbD
o0cgXMgdbsnyqlGSx0D5rPDN7gBKLZ2onwjsNEqQc58/4N+OORt5me1z5HXZfny8x1ZS0OXOJKeS
0D+dupwyXtwJBxdWoj1C6zEWDseJvV8IlCi+Q7A5xiVa6Ml1mQJDKfOq/v7FVzo+nM2PnT2KhaTN
023+9/Er0efySsdqDwSGanMbM5JPRizJHZvYPSZLVfj9eVmPsl4P1H1i7Dn48Fai7vobcnhzOE0q
T7B26OAUllqg1DaJR3p7WqYb3YnI6/Tti2/8u4fKhMxUyCTIxuZo4mCd0MuhzA+dW4QTgRvQ/Zae
DpyE1Fh3RmGmLS6LhnS8eulLvb1UaJvfrKnnnMszJXjy8y90vPLPd3A+hHk8V937hyivIasodLrq
YGj1FOOS0VGUzAEdXw2e+QU8HszoCD3CGVw2Gs78bv0yYWaeVSRmPF83uAUSFw0D9BlxvWyj0sJb
Bmle7ou6RDFC122qYddhQFpVtZUd4iDEeRcUvfrTSikX7wvEkoYJOWc+gX78UohQQnPy/HPpjf5Z
iKbuqiNr/Bukxv7mj2+zLzis29RJORsdz9duFIiUTvt5ObrDniRdeDFprX1Rdv7N/ERh0bKgnTO/
WuJog0VKUBso0zuvICbuAmKtVwUV4qs0JfJ2AeUh231+Uf+c8tGGIirFek19CuL0x9tXTEGXN313
ThChfNRBbojlVPRFteg9Rbi8ReIbJBE0mT0TUj++EkzTxl8sO0w9xyOL7RfNJmy+HIfRvh5NkxyU
okGp6hyE4UTDs+/qcA30gLS2ZoajWG1/5/g2rYgozdrhRQgsCcgo61ZewnAQiApD0vvOkzwI0Lz5
LtbUKYh8tYd8gSLaNMpJe9ARzE8nY53pJ2Tjzr531XJTVUO0IoijPOwoT7TDwZiq9AY6af1C7R9E
h43GkIy1yWtm8UWB2koMWtSt7dzVngFXpVdAK1LknqyJL63Uw0PZD+OL7ciQ+CNok8BIQDnuhhHt
xD4ksFyet0439Jta2cRQodnXli11T9LSrVxdS2E0pPYR1ueh4DYDtdFRM2G+Ms301UUDRUJSZ2jX
NY37AuaQLDr6v3GyT5Oyf6oKa0xXsalN5bKEDlav3I4cdMPCcLkA3kR3K5wm7yKOrRIQT2uZ6ZKm
fqFOhsRXBNINltq1Ba0qPI5J5Ppompyces6As5Q0pso3wCN66ITQKDSxF7+0qV6A/g9ZSNDtCZYU
swfyvrFSD2hG6ZO1Tf7YrP+BYRalUC5jzyXvs+CArM0KA+UBQSXy7jzwHKDxoz/EwyZQmj9c+kXn
ba1A8p/7omnVTuIJ+FEksT57HfohXKCChO/XBmFfL/R5Xl54VU9WfeA10yG3gPks2bzVKRGphukh
pcoGHmCa4c8KDKa/uxZMm1olQqS3Zmc3akXqRgyhKyjpuqO7Rz9So8Gs1xbhhhC1JE9nBVu1ucJM
xcpJQJZ55cC7Mw5C4v3FctI50H9saWSYuJVqdlA3pid0+LA9WzOSnEmjvAiWiQkGiHVKRRIvW2y8
SY2ybTBpw7dSEXd5UpC2q21DETQvpZPi663jkWhOxFxtBpOhLW9a5GVyNQpURYsW4oaxRI5iX45o
Kq/DqWYE6WNWy4Wqwc+ipRhgK5QNKZkr+qCMaj+oJJ5q6SHJ6m2od5tyLAzywxurMxdRRcV0ib4B
5aHqjdFfkyWfN+so14R1ZmZQulZVmYTfRRu1+ia0CvemdMbh1hpNcj9FnETdhubWECHBGdJb8K8e
C6Oexkh9wRtddkHfXRklTbiFYuWHSTX45quTDhXQR/KR1vkUd6eubVVbK0N4il1L7koQutY+sPlr
lrVPilTfV8kdSl/EsoFqotu4LowzpLDaKbytqMCfYqAbz71KOftSK9rbVvnxxdAGEmFzFDO11dSE
7lvgfqS3DzAn12rqBXMI8sIQrmMH3fR92v1v7QLaBSpA/167cP2//4uNfFl8lC3wKz9lC7b9Fz1y
jpj0p+ez/1wu+qla4Ce0edhKs1Q4YELmhf5v/4Nm6n+BraDM5GNPgBIxVxP/NkBopvEXJwrYERZt
TjBmlvUnDoj3DfK/9kC0Vgzh0Cmaw4RmsPqxcsH0ptZJZn9P4RKifiC8syc6cCiktgK77LgbMnN4
f9geJMFSdD7S1cActZ5MMYHkCI33xExCate01TDdA1yZCl/ujcHEZtTRD8lOXEOjPFXZEd5Rr+6h
6MDnIGNY0tuoUDFH5iWnBI3E2cgH6iVI8cBmmLvNaygSH/4bbObrQE4JGAEx2PgHiN922JsidBdh
b6klWPBHqZzyJdRiF6RcU77++fC+qN6Km7Z5e2vPv1f/c34zXsqKYLEwav/Xxz9iQfn7xZmxJR/+
sC7auB2v1FszXr/h7uJX+YvCt3L+L/9ff/g/3t7/ltuxevvP/3gpVdHOfxtAyA+jkGL0pwO3/168
crb5+XftX//zP95/4eewtf4PdWe2XLexbdlfqR/ACTSJ7rE2gN2yJ8XuBUFKIvom0QNfXwO0b1mk
XeL1W92w44R0LBEb2EBi5VpzjskNyGZSuDbhHatuhjLqT9uOQ/wUGgIwoSqpEHSf/7pttf/gwFjN
PFSv9Gn51S+3LTlY/DQmVmtzgor7Xxl3xDtD56/71uSRsmhvMQzBAoQY6PN9W2H0mDvXvu2yGNFL
QprghiRJ9yDrsbnX9Q7hp2thPSXV8bpcZmLcNXN6VdkuegN5Rj6o8MyPKJsuCMmennTi8G5nuKV3
ZmXU2x4p2gH9bIrmXbvjAVi+YRqGwxS30XWY98tJoHoOCLfEcWEM0by1JL8v06w7GFCOPBvZ3xkQ
SQe/JObSTZezHd6mStOrfo0ALZB42x8zB7IIRlXss35S2uazWWhUyODudMvLsfRfwkV3Tqk0UdxT
ChZHqyc4cdNIC2zzVNewJ0jgtHNPzd2swcrDY4s7OdmrQsXiQVsSsq/Zifq6MEorPnRq39/jSU0Q
lotZXBdjRm5x3LXnRUhDWVahdiVAs6DLAxFdzWZ9AB2mmJus7MiWlsTmERkb+V2tHdEaljilkwu2
i+qJrJA1dXq6Gu1H1+ivugTxYEpqOtE5KCWf8SWN12h8jygtX1F/nhFuHoTFaakSXD7dN7tQPTMj
AXOcbOqe5laNwx8KSNKjbMbHmsjmQ18P+mUjUHiyVG3wagBCT61XXZ2cM1yvRy7VJdDJ28mVdSAG
0rck2dtzGEevaYr0L66d74DAGi827elFLbofKH6gvIIZeZrM9gkS62HUlWPRgO2OozC/oUTAVkOK
/I9StW6tsnkTi4aoRNzytiZZEYRh02zbECdYqfAr/NGCDoMhgL0n/OglrJptWjs13NFQDxpF3Fh1
cdcUmjxL9fHFNBA8k/Gzl8PMNe3hy8OKpXXHEOtk9Cki7SqBazqSLcZkNMJ2MYLWDcdGfSNmyZO6
smFjiy5UgaKoQxSE/gsRZWdCJU1IvZRGl96PIpyPk215GQqkfHgcgFj3P5Skv20i24/KJ2liqvc6
pnWbtpjZ089Oqweyjh1sZgL+ND4n6kDTbEKonShoKTPCuT+WEOqBpRsYGs40MKcvuC7Kq3aIrMCB
vnswYx3TZlNrqM1h29DqSEs/idviHsM5/Tj0A0hNMLvSHQXFy+9s98pOsZ+Mc7tHBPuAeS9ojOKG
2BG/iPTbdKG2yWfhd3p93UewOMwJsJbpZu2pN7As5SJ5gk6wpfpG+EUFtmF+fmyx+QV93Z/BK4/3
wHrOjD4jTLpbZm/VameMIHDkjKjq4f/EyLXppzXqcaHk90hwrXx0ZyaCUkUFIbLwP2KxscnVpH3q
7aXUAKYjug/PSnXCsFvkZwpd/k1RAqBulWIIeLuh3S56xP9VdLuyLQ7lPOl3Ci7xa7RtoVfTjgKU
6cxb1x5ztsZd/yNPoociaci/fuvmTLuDAC+DQlrKfWkJ3rHSJb9SPtSl0Lc5cCNvMrR9VmCVs5x+
N05cD4YBJrITkoUHqyERnPjlDej6wls6FcJA6/QWMQZiL6bQ2WrlqO2MVtivGtSGbR+P8FDqRX+a
J/cmysBDKCpQgTrdx+X0ysbvuopHQYfNAjngp3HV3bbD7HpzkQ2bWXWwKBVhCqI4oqmffg+5dD6x
F7gkQ/N7PGSHWWbg++P7qG6/i7nPXrOy3acNlWoz6qtzzAsLkbA9xRimm5eJ6CFbmjeK0taeqgwU
t6LfT47KRp/HUXWrfQK9v9L5DpJxAgMeVlj+831ZhuZFCljgitPBO1ktyUVhGn0AfibcK6Ifg8ox
jlE3RxhrRnD3mr0XcYISbgFMoutPbqKPfOP0TO66comO4ArBqSa6C1SL2IyB/do3bAsPqRS7To0N
37CeSG8q8FQ55LrUgFfCgMVWPMS8P68Moza+1WPPqu5Er1qi8+xCzAGLAIlEpnJTLVjbRBKZADUH
8Z0Ggs/S48QbvTOVQ+2yfzSmWDkZ6qD2LzToipPQ+u61mtaw1kk3ze+lrpQCvboYEaknYMiQvauS
qGhp7xItGcB7NplzrleV9o34DOlNIlVIaVfNi5xwgIuC3m28sZrQuJoaJJ1d08C1ymZ3C+26OYwN
vCXE9z3bSQOpfOW2+UVTjvF2xF3qKdmY82C2qp8q0Wqgdc0N3c5kj8uR8Fkmiw91hGq1KC5wb+wb
MgvrYl9NQ75H51DujSUfevyFYFLJPDgM1bhHWfHGKE2ejAmsTDTlAMZayE3bRApl73RjusUtF25t
zoWUl+UE/FO7IjfFiyxQPKssdZis+24agcFOSX2ztKZKPsPLsKTJNhxq+5vSz+F2ssHRdCpWXygc
4z4VbRiEjrTuIzWrXhQjX+4i8KHBRKvpnA15eo/PMj4AE1V2wkiiI3nP8THTXeVCyZv5GsBn/ZTM
mGc2JMbPvD1JBjlkotB5YXfWTdco5Rmg6vKecW35GmvWcptMRuir1tT6pQhpWBdgnZhh5b5Vrv4W
bV6+//sK9zz53lRt9dZ9LGffS9S/at3/aXXwuuX5f+/fNk1f/kx+LYPXP/+neR2QoEFaKbJyVAeU
rLTy/6iCgXP+R6U2ppYlpo+JLv/lz82bSREM6ZKOKs52hiQWO74/9278HXV1vCPdocu+zs7/zdbt
0+wD//u7e53e6jr8Yb68ttF/aV8vtaLGlGnFYUlAWBnRN4WnM4jCkqLLnXnts/y4KYCNA6SHDPnc
wNO31BcAwJ5/uWRXf5Tdv+rQP7Y7//wk9F1xRiPtZJv78ZP0K9kvDJPigGnnAKw6BJTBi9gkU+Gr
nv3av/2r7v/jUFxDtBCoD8nT/TRdkW1qqLxIC0pZoh9FGegTsgcIiHujibVtTYt5k0VjfkHR3nhL
Us2B1eTplmZjstd6gCe/P/WPcpD3z8MEASGIaiHyZqv/8dRtV6lmdvj5IaxG2kmm+whkJwmaWhDr
Mtp+UWXQsVXr2+8Pu57mp8vw4bCfRjb4bfExyTk/AHoiW57SbEMRYnia41z//kj/8N3+eqTP0/qe
3TjzRS0/xPH4ylIOVnIYNv1iU558eVYrfvOX8+IuxpFBm/T9YvL1fh6Whw0QbaQuGTUPqfOkU2II
EmGOu498hca81+d5R73+1oQHs1KCKDvWMcC2TjiP+tzGu2La8dhuQ6fWgl5gdq2iQzfu8i6Zg6Io
s4u4wgEuSt2vI+lrmJsAmCnVjWbq2hVZlC3VkXg10/iSbjQvtVR7DPny+Qbfx5v7OB6+ZYuQ29Zq
v6WKkwB7AtRNIM/gM2/F/JiETywQw9pBpS5l7EfUlgQT6VyE6awHoxFW9w07MjqQQ/mkt8rF3GM+
n434DqdUszXT4UEZBMSWhCA0Xb/VFn3euE4Un4O/Psf6tWuLooe5BB8/wkSvTdlR65WtAzMLnh4z
VoA7FuM6HsQ27r9ZeRzSLC6ocfCU3bpGfRJRmV0SvUJt3TnbfMYL3MdyIxp2s7lZkrfT/SQt7od8
j3tv813Hjobna/F6JX5yFnu7sL2qRhVjLq7qxpgCJ6m/kQj1qJXsIixBsLO6q9rvlj4qwNDZ4gDH
qw59Vdd+pLb1fmrdfVvpe9aJx2HuLpNM/5ml8+g1pJnsnJlOeFjN8FBFTwmvi43o+33NSH2Tjsa3
SJt23CivShgrGN6wfvX5M1AsBx6zsxk7uVvaxfWLnrwlRGHsmK2oOAMB8Kh2obobWp6XpsvSTdMS
B0FT47ZpOg2rLZPtyMk3DHbVYMhIu1Db8Eo3AaTNgj9QWfe2xn3h4ugL1KRw7rveagN9Tp9hhqyG
RzpaWTnvbLdmzVkMaogihHIx2JhwKl0/TmhjACE49wAsX2nvuQ/Eo30zF23alHiHSHJkp4rTzCuH
PiAoGxy1TeIJWtTJEtdRimWdXXhQykNqy+9gf2YXhms2X+cEYilQR2IbUlMXU4IqcXdUikjb1DI5
xVoJYC5USRYZb0JFv57iHuJma18WrXMNkULFkaL4KvQCnpoiABh/gzHXm6dk9NUp34NHu7ci9S4N
6yOrs2cMsKuwQk7pA0aWU6vd6m55iKYfmHDO4HZ79ZTv8iGoe9PPlXjTla+qWHxzaA5O2JzrTLTn
/LmO8FbDOhxUZR9ptxELejWKgK4iG00q1nTdcD3iPGcFqAJdhkeSLr05J3WHXNeJQE+zfqBP+Q2S
ak+X0SVNIim3lram4qDlznbG5OvKOe72jdXvDJFd9Hl5VmdOYMUXUb+LnBuEmweAdIGKDKlr8LA/
R+SqdJxd1p/18jKrcQ8202aRz6Yzv4j4pWb7PLdeT9KRkm7s9EenqEGuXUXatyUWuHD9qea2pa+p
tvxy8lylBiroj9GPtGy8Jn7DfAvUZVt3P9aNStz7S6GcOn3YOvVxKm5glvuhqwXjsBno40AQ8RJ6
ClZ3AcEsMBTbn1ZUIJrPOG62umEFivsY98/55Nuof2e9OYZsXZMHLq/bTjcTo89JFqQVXNQViS+5
CDSgpoSXNZXua3F+WOZbzP2Vrp6Ezh/IQhin4piorg8v5ZgCw8gibuGh2FaEKPUwyQ353SyWYDbI
Bm13yqL7TiSoVONLHXIibuEAHyojtT5Yr2VRsfUfLRiu6M86nkr4JpJBJzFcPlDfDVlBRqHfmJJx
WnRb21VAlKpP0sCOjodPSPwWesYW6zLdX0Zt4WOhQfqDKuymgbCWrRYDZXTpGydg9BvLq/X55Ogv
SXPqIVmmMBF7Vz3rYm0v1eaeuBTPKcW5HudPQHo3paUGpno2F83OVBdgaqSr2ImnNGT3qUGfVX7b
KPsYXRoMyCUNTGHdiIo+BaZ8cuYAhvZgWKUnzJdlvLViYiYccV6i7rDEZao/w1zwCHHgp7Dfym7S
JL5wm5exvIzKkanMd7NytkRmAV/vsM2CdZnA2KqJP4whFLOLLu93OhszmuWmQTwF/QK5fmxp5jAk
+5IvjFh032Crq6XqAXmT3FZa8lw2ETFWcKCBjhrtlkiB0k8j51FFqeUVHU5oI563SLXPAf6Q9cai
Qb9TQ0JU3dMFe5NFd07bczkm+XiLVtA9hRrZTVWeFceasE17uJtD583Qhyv2hsK1doqIHB957KkC
0DJ1zo7ZZQz7Nf/JXAAKWlNf8M46iTT/UQ2Ntk/S/lqX2VmD6gKvVh506peGMPWjzmMtKlyTID+C
fwWvP0xoH2u0RGvxUJmusofg6Y/JLG/Y9dP3Lm8RyQ1BFi8ntHKp39BozjwqFFMQOKGqJ9ca5U4T
SXGaJ8lEkSbWpQObblPIwwBbTmvXbLohYPzxwoiSDKcKdOiPcJHC8h1WH6KP7gvkJXdSsR66MI0J
Uks3Wv2jzgkFm1Pqgg74zh3kzNyTpTJdhDnMM8Rw5yI9uLOSvGk0Hq6QnxQvXB1bPi31ZaMMQdIx
DlcrPkpL4IEAhuL30XK21J5G1ygywCxF/biJyTZVDG/Q1LNR2CjfNRkQpPmwlLRQ9YjXKZ7bzTDe
ZwuYXzqGFuGorxUMlHnIh1sNpudJVIokK5LDdMQ2XcVkmJzPKwhOHWjxxAtQZBXH9Gs8p9VDMlc0
AOR513YX2BDB2VoOPem5eBzNkHw2xNsbldWkiIHgVAt0W4elNXJo6IwYSfqlekU2Gmhp3l+Fdv0N
4owIzLnBW57acIDTGRKX5xakwqn6fKm7tEbLAu03IscmALvpeGXvhidyzyQkBgLiNjUeMACqeLid
IVe3Q748pyGAH6zvYbkfR6iiJNjxKtHbY9mr83XVaQ+VXpleTw+wEbVyrjQL96sTYT4hcRiyzg+7
iWYIX6AWS1kDjdTZgqUzZQnat2qH/cw5UngJXzJ295xmdYZErMgsIaxNrtQPVTXsIdg2l20+QL0p
q91Udt9TF5V3wY5mMb+BnGFiLg6GnmQBsa/PSGnvm7h7jBSUYe0yAzKYrfZgdDzWmU64eqTKHj54
qp1j4cw3xdh0GyZYzXOIThHFwaTxDUw17KBuXoDOumOP2qEabtHkPNCPUFCT86KsxWOEznQD9OUq
67SziYgfzD3DywJPmXutTk9TNTUMOcLLJcLsW1CGLMQOET+7U3vY43GTkyaiRVQiAIF8pSv9rrUf
pryhwjCGRxT8snyu0EcQdUZmIwP6OaNPyymDH2Q9gSeuQC8bhE4oX6ybEC6JOnTbayXrOolWYPye
YYaELW8X489cN86tHnj6UqMZI9BHD/2UO0Y1X1L1mGY7DTRK5jaJG0Cgvuu7vn4p1e4FvglBTjl8
m9o9WGYWEcqi0I8uhoSz6sXBbJ9Lki4Xb+6NGUFBV100Wj892JN27Abdvsq0uSeaDQUzfozC65GD
KfmJZJgKJHZGnOKhHsrkWIZn/ezsp5ytgiLONcV8FKR6rSpJQojpuIK0of3sO+JZ79IGhbBF1dTP
gRJC/1lFO7k8F01ZeusLbXF3PVjKEQmPr/MY8WAfiEHOw4p04/rcEgDmeV9CYA1c41Tw7Lvmm5Zu
pxUezzV9NfqdMiIkceXDoL1WLf//tEXIh+6m3OlTFZQToYPyboXSL5n2UBtQnMFTVfVtZYKAyOOD
m1zJZd6gXTi1i7zSm+Jcs8/G+kEOJ2sGUkYVIfQXZ7xSF3hizrCFqaRv2uQlA5FSdK1v9t/JQLXx
RHe7RSp3kgeW1LyzyCHQSDeYzumvyVIeIbgRFRvTRObNWMKjqa19KyEOxYaXTl1Bj9td9hUAIejS
Yqu6NPZrNXDBBMG5gRX12I8/i/ZkdMR+Jg2MCklSOSsXndNTBC4iK9EmW+OxzxugmuRarTUVZTRc
K50krYO0WCu7IrV9pShOWK72QtwXmu2HidgisNuMQJgIhaX0hgtqLQVkumWXz3c2S0SfXqa1OOW8
vPPhLo+TV8P52QPjLdOZVi9C7XpIaiYs6UUznSshZdhEAjYoNWAlmnIV660PkMk5nxB4TZGeIuQp
ftZ2Q29/HIHNjAZdVw3s85/B4f9K0nFXFfz723bgf69puPtZXbwUP9vPP+rDGP3/l7n5bwUftz/n
7/HPPP/Z/to0xP/0X11D0/oPKlrHQVWhW+THOvTl/ugaCv4LwMm1W4SqREcR+X+7hooBwoJRFC0k
DKhoBld7439JPiBV6GiDsZsLAyssf/vf9A0/to4cupXMzDUcjmt3El7G2vD5pW1Y0mTQQ1cPN30u
lO1cEU8VhcwIyP1xvd/3jtYO5F9dqj8PZVuM7Vb5u/XuaPz1UGIkLEt3oJuRpevbykq7gdr3RU/w
70exDdWGDMhVswme/yS2lIiph0TmCjReo/CtpmX/CONq92/PhcYRPxy/sbkakj8Vkb3KOYR5Q8Qz
5KR9ERIr0nZtsv39Ud5NnB8v2WrfoAdG39nGPPDpZBDprBl0MNMce/5BTgSZWIhsgLylPfo68qYW
+1gjBwS2Qz8jJHZM9YER+JXabFQ5bJbqSq/Vc3uJb3//yeiCf/ou6eviyFIFskLE0muR/ct32TEV
LdCPswoXhCnKrritIpNESNCYPnfSzGwR+OHvj/l+g3y8GiiUV9QrihIO+TfOQlwSS0qx5rll6hwm
UKj0fXWCRie73cHZqv3RkmPg0EM5oE1SvUazLsrYmnaWUcZ0YBmlRWbkfNH0XRv/ny8GjAHkLDpU
D57XT98S00k8hm2JlaVU5tmv3HkrGk1XfDvtK2vTa2s4MnAv5aYswit6a2vRmxIbnKIgVYUxnjkA
oXcLkBQmgHb0083UxSaDOMzonpH9+twvpnJyBFC5QQc86ivMpzapkoggpNYvvMZI9K+8Y39/kFzc
fJhWVuW5ATPn41c8UvuP7aQyh7QXzOtGQlJhJL7yf31sKK+LAkehz2shkWZe8Dmma8mM2TITI/YU
ttoBWe0ks0d4COrKkJ6epfYXi9A/fVcrnYfHl3/w4nw8K0jukhaayRMVk5wwykHZQDG12JOM9Rf3
6z9dQJjGK6Zo9TC8T2x+eUaafM7UWmqxZ1ukDpLvRqM81cuv7r51qfn0VFDDgbfQCVWjmfxpKdL6
mlJG5Qouwi0vklGdLm18A0FGuPGuq211q2qJse17G2AYMQpEIWo66YUjRJzzIQxgEY6Mam67uKk3
8dwVV3HhTriTFHNPLsgzSq6E2adCTwO4WgCgoT2Z5USLKzVoSEUSkXDuWAfHDfMv1r+P45T3m8Oi
m8tyTomrcm4fvyx1yKqpR8vidblBZ9B2Wk8nF8u3aT96PQQOCKA9MSDtV5r9f/jq1lkeHCMVLQcj
v48H1huDOTMuYnKUjHjvypEuEH15//cL2j8sorx2TZ12hIlZeh01/rqIom3Km1IHDDyAF+B9NU+7
ZZ30loPL7nSc4y2cZ/nFQf/pmqIlVRk+mhgRP+MtarNTB16PsVfEAuHHlGZnCjTdW9gyct8gBXhg
c5NvHbtMDr8/3X+4qLyXKTGwofI4mOsn++V5yHhGlnEGhDkDZPQU+hub1qZn/Puj/MMD7vJadN5f
EhRRnx5wh94JzCESxHOyFNl46NPelurs1ygPvrg934ujXx896jdtzW1Dbc09ggjx4xnpc0wB0tVi
w0jsGSYdrdvJtxSFIE94XwR+t7eRTdiT4tTJ1dyUdzF83o0NMmzH7IJiXxq4bmFbk7Rbpv/ycv/x
4SAQmKDTIWR8urvcUEjMe3y4pTfj6xGA53kIKfiL9fRdWvn3a/DXYT59qxUANAv5EJTqGAwjG2AN
umlNE2WZl9dMDeNDa4btmVoN853MV2kIthAyzuP+OsEzQks4/D6hId0kCSGQjav1W2UunnhlOIHt
jNH14KYjG/u0CAzY5NsiJQND692fv79t3oEhH8+DdiDPGWs1jz5guY/fJQvznBPIgtHAcRi1JPIH
wQ7uPQ9uQmqR3b92YZlQ78Bqr8i4Acw+IrxQMdpTZ9UtrWMoKJG2qqKZNyAZirCSFjYRQxXk8RwJ
tQpz1tSk17udmLwsGUfC0sRASFA0JLnwdaQlG6ZSQ+TJhWnU70/wk0CA68VrHF+ku1Zr7+rbjyco
l7AYbWDrjGk0sJQJbhpOKw+mJHaPVB0EzIPS9BACNwEbnPEmWe2ILtvhsFC8oqUN+vtPtD4dn664
jZ4d5B6L/CqJ//iBWqw+bibIaQqdarrPTeONmGQy2EnFCSyRz18c7hM24v0C4L8y8NM5KC54K388
HlHxAuYxDsZxnLxp0BD6Wb1H70ShU0OvP1vZ+ksbMi11ZBZUWSE2hjt98Vjqa9308bR5JFj0qV9Z
fZHZf/wYs5M1646CXqte4DVSswjHhtV5lNsMmNAE+RMY2HM9b6sTtHBSIF3ZeF1ROaADaeyQ/ae9
1HrB8lEX2ZH4SJrGinDvhgxdWGeKn1jRvvDtfV5U2YZiQhT4AzSLdWU1Qfy6dGurDBp0Cfj3Zia7
vVS+55HGEKgkOOb3N8U/HskUOPFVpqow8j4eqZOybgbJmFhRyreiKOSuNsuRCClV+eJI63X+8D2g
4Vm3ilgdITWK96r+l9fRXItZIzUFYL3UzP3zAUOwuWUwPvpTgqb196f1t3sd9c87VYKURV697nra
vxwMh04vIaZSybSLvhMx8W9Y4HZVHRC58tVG6e9nhiDf1kzgEnxf8P0+HsytJWkUI4tVaAH1JsC6
agKiIOVGzc3mOnPy5aTFWfrFm+ATgobnixWGxgT7YRvFv2p8uklQwaKSU8rMwy/iO2p/NxTTOVmW
zHncU5qMRwSPO3iuZ9R1XzxUf7treJwgMFlsJ2hogAf7eMY5ERKzC4rdM+KBPO+wxn5GPhGV9/jV
N/m3i8uhEHqZpuCQtE4+qZsYeHfS1qli8gjdyEBE/Saeajsoa9T2WUrQ3FjLbvv722eNP/l4s6Jv
4hHkAuM6wNr/ae0a6KiSVdVRBLMp20kilvyUGf5RjmO0w7yOrdX17NSoL+uoE2eyCbtLLerdA+r1
b198lk+qHL5nPgscFl2lX7QyuD5ebCcZ5DLxHXqAKrG02+1E2r3skX/0Y+3lzGl2NS6Hy9raFiWF
Jv7JDVaDLxBLf3+fOajxWI4EPn9u888UIHUUAmYeLj+F6vqKpYRet15X24btlm+40Y8MhfouhjCF
MWDSLi3MgLtu1GYC9xTz+1QYu/cL869apP+9/uf/NNEkVcMv98jf0pdvq76L/9f/fmuS7y8f26D8
tT8tRM6qdmSLQ9SxtoIrucH/FE9a/0EVue62eHh/UU4quv4fOBnrM4Z5W2WvLv7qgdI7dWF6ri8J
NofvvdP/sk5d/bHG/y74h5fZxwVknQevO3TAWTxkmOA/K83wZ9AtGBBeJ5ZW6IiS8NuavILtmnlK
1+MIEshxBqVs7TNQoksmUTwQlrZZR4cM6bTFEmdW0cvCb+pmqjx2DLNCwE4eLxeCUCHnepTclO7G
XLoovMmEaIazMiUuMzDU2m32S2Glu8wUUXTUx1rr8o1WYoHzE0uMw621qIRhbuYSLQimYhQGftSB
jXjJSUBnWpkXeqQ5Pvz16JqxyTL5psur+llts652PZezjnZZit7IRLkSztMlvvuppt5BUTwEY1Nk
3bfRri0bG4lg+z8585JfFlVBzmdWSie9VXXFzG6IP6mLVzD69jXhzZZ6bfZU1Eerki1xOhMzGV/X
pmLYFkMtq30+NINzB8m8Mls8KA71gjsQePhaRB3Ogc5h1aby7QhqPaRWMrjnQ9U15NIOi01UESFS
Zrr4XcGL3AT/v4zRhebIHqUdp1fNT2bnKsuR5NGu/gm7l0zUTTcwwnrJ4yqT5EcWa/YlYnmswBtz
Llt9nzGgy65rLU6bZ7w/SXuRWIqjMPquR8I2ayN13hwy0HoEotXS/pwzG90gxpYsEerqCzGYrucQ
bfIIjHBX0qeKG4roye+spVoI/OUreZtUMm2wcS1EzoaVVvG1yYJdJEuhVrvRZTkK+hfeTB+Q5aob
AOfH70Gd6GZT6JH9+uebvL2EdFEZF4NbusujwtYhMcgkTPopRHNgae2zmLQ2fFx0QLf3shur6sqW
ZUA49Kp6S+4Ak4hTNhoZtgrsaNHojuS62aS/WfUPrcrCyVOG4RF7BmMnMAPvN+51nGWVJ6wp8kEW
0/wowKsjgomiiQtBoMxVGlW28WBg3u6fpJ7l48nUGS/TTqEB5ROBiRLK6WvROz5K49LEQU+C010+
VWVKplNabdNhWa5DpauJQiZIAtM4cSFrEDe3seHG+aY1Mz7OpAHS89wktZ4kXXZkEGbSuKVXuGOi
XmQTxpyrUXHDKPQix1KYKFtJYpEBQ3nXnyW0G9RdoujT8ooMMVzDcKcMJBop5dVymesYbR5sAhee
shw5Js4BklHA3PJuqEh52PKEhU/8UX2X1r1BOqNAnuLJiH/O3TxurCO9NUhvWNSG7kapSZCNN0Sb
6OgIVYKWBxyJlVAek2Fuh9cZfOn4wyF/yzmoFvml5LnnY3Iu57rS3xoVQ8FWU0iuIIpVpmkQIwHt
N7SEcI5eNm1ddftFaYsb5kKYvLpZhuy1G5kZ3jK3ZMH2baMG6mCzuxQ2Yhavn5XqSRliieYpM8gM
j3uWjos65Jmhw072z+JyUaFhKIRhuVnm7O0SQv6WaQSplxXuIs+1uwops4MAQnf7nHl6ryAjn0kl
W0XGmXEKl65Y9rgVRMzsiLyDjVpHDjKosSoeyXkYW2QHbnZSjGa4quZCyX0jTa0e75DI201umOVj
rxfLz7AS1kmzksUb+mT8UenOEJAIbt0UsfO4hOaM75eh2CHhpImfIox6O+qI+ooM2GCoLiQyT5L1
kw+iOJvFVquDLRNtBxN1DBJoYgjNlLZ9mlyyYTZJoSTfmXUpD6UYosuOn0moSJsE+WzMN2a59mfw
au9k2M9npZ4Xd1FajNdtmRn6MbTbN3qWXbMJk1JspbLUoP/c6ltqjw5N/U7T3wYkQGBYibaDv+jY
m2ZJ7DEonE67I4ZlwTxXDtGb2hn2o53DWfCmntF+MhP00DBgzo+9BS4pTBzzXuDjWXZLqMHhKPKJ
FI1Kz866oWAuPeihvIxdhTHxiPcw0MiyQqjWGtPPvhm+dY2FRNUeh/IRO5u8YwXQkYcLJWzQQCvZ
oYeE98PJB/ciaUllcsySaKZSn88JtgufxzhetLO86kZyHPIGmaVO8KktU/uayzwdrMLNntu6J7t2
zbzcDg4ntSkjVTSYCWlseBNDUK+UmlZjfLKah5GXPdiBSbfkzh6EuMkVx2JVtOPHUrWH82ggnEQN
NXGHeqp5atSxJ+/Dsrb0S5ObWhhtIPMJmLGtHGcnJjrOqO/UbJIXo3DH8HKGM7FvUN94Rl3gWcOa
RDwGXSp+3+2Rl+prlFcj9/1cqkcSds1vjZa8ClmXR22KzggqIsEoR95xr9VIa9g/inNb9JfZ7OR3
9bIs/qwN6OOaJaaUrPARJeFZV2HSNfuuue5z8jLcZS0FDLbpT0nY2kcGIMrN2MIu6cqqulThV/o6
SbtYyYZmJwt7CLAMK2/5goEVJUba54gNKnE9qZXMDvVcIZBdO1deOw3RVlHT5Cxf+rcoSS9dUsJK
KcOnUNOvsOy3t0JKJUiTRjxIBYaekdQAALvzRpP9gSBc5I9KVahvYTYUm6aJkQuAydCkiO8VBZVD
R0zrVBbi4EYD5ULbHqVL96pQBxYWyAFwkKcGLbW7jOHdRLzhljffD6CcyeBZNh7juuh3LryWUz2W
27JsUukPbY59uNabjDjZWmUUknSXqMOnE0WOs2dBdc+KJcVxhoz9njJIsZ5l1QwRbbgZFbual/Im
y5lzbOpcLj75XxC8mQZ2D3mOCwr0SeJK33SqtkBhSOpb7dtRAxLTManW9iifUdJqizraT7mrDa8x
UaPkec3xvMoOSx/vleortfZW/x/yzms7bmTbsj/UOAMmAuY1E+loRC+SesEgJQo24AL+6+/MqtNV
Ul6pOIqP3c9VymQCYfdea664T+ctq5x6y9nzP2GKfCwqgspVm7A+V81CJ8JE3RPRIjh3EGzsoy6w
wsFMFyy6EsIXbGR7VXpmc1mQwLQGZFhvvQB0zDRP+YWqZ58swcGYN5nhyF3lOD0FuaSItxVnzc8T
eWbGoaiPy3ZvxVh1eyslLcdr5/krNr9j5MsAJ+xKiAiVVwuXR06lvcHBB0bHGosvQ5Qpks9Ndwgj
d0AC0xp2sM20pzfZLOpNVNdXdpaR5CZ8D5ADSQChgZN2XrWWUBcwkPh7UJevq3G5kNFIsKuqy/KC
HJRpFZRzuats5D9r1/CsrWGNaB5zw7DBNNgFxgHNgrpyib7cTot91GbT4XQg1qzrdKIezZV0/BZk
eXlX5mn57MObf5oxOZAelHS3U0Ba8Sr20AkN5uw/+q3u9sOQl9upr74tyjP3JHEVYZyZcKSsUl1W
cCG35D0W39RoO7s+F+Y+yUd31QR9y0rpqKt2MJNQugBddKzT22EUJW4Iw6LBotQD3YTljHqd9Zig
MSxSpGakNuJYyJbhzZY0uKbCe6sYDTuyn8gzRz26qhOgxZTcbjknaHbTlG5K0wRyjdzWv7bJezxk
ixdftnQPONlNaG8XM7rMK/2WFjKj5ph2yHqFaG5b3qZzpjVAOoA66lE4yiDExwTbWBXJK9lr7j6Z
fWacxkL9QB5xsROa+LNq7MUXchoLXOGK6E+uIhB+yYz3dt1Ucz4lLSm5EmPbA1bOiN2NYKjjTu9y
SWfEJH/L66dhXMvM/l6msj8UCwcMbJSmtxk9BR0nTz2kgjIHlEAoJ0J7ux5duoWgg/HSlhwaDFsc
MGW32aZUBCxg324j44xWD/GEEX7Mne4i+0FlSR4wOGssEH5Mwt0ERP3JsFv5Xbpz8Wo3/XiZEmcY
eotov8w2tZWFOK9q3WaoF0mvL+sXxDTqDEsJOuol6qf1vAhzE1PtCRujbYYbVXgJsnp3iTnT6evC
HsUnalDtziLPfaOAXd96li0hr5IkvtYltXAy7DFVCELAQPT0RIMX8F3OXHtBQFGYLSPRab0SgX2X
9fllQxYVxgKl19Y00k5FemsQGqlyGQq7gKfkJcsFtV3PvKwY20VIikfLT4Kp6qDHcLgKMmLHTwG9
2PtpGVm2DDKV6vNJZt4+oV9z2xjmvCfvWWRnQ5t60bGgqx/GmsrQaqSMsZ61mNGiehYOf5x21vTY
6/mSdlNF9pmBGI+Ttpns56R0Npxh5LUDFXJH594FdzCaDvy+qr/2WYcPYs6zi0kt8aunla8PsRnb
3iYnhHQzCon1P59dFq08rYBVBiCOcEAV7XIuK7JsVw5aZ+zpff5sILU5jwq3vY8nNNBexcER+Zs0
vwu/U3ioo+xgsMo9xr1MX4fMSjdVlw1P2E/Lq16wPlkuFGN6MwBw2y4xrvqlj698lnixjuwqeKQ/
dDzCkr+5nrkgXBnVMUUz8+QmI3Da5/TgmJ8IxvA+BZUYXyzOlJu5ccXXAZBXtS4zaZLqi8jiqmBR
PJBYIC584Zb3pR+UWLNjztO1oMYORqOrb+s6MLdNWRTns9mZX1yyRqF5RO4BR4hBPiq9lG+COmBo
KUAhvtOON+ZSCDSOQTB3yLjlkZIm001PY2xXLT2bVtIED2SNUhIwhnEvSBR7FLnfbhkR9Rdp9uZh
FlH+dS697KJJff+s09W4qyF34yso5Vnj+suMDQDPuGVFBzgl890cGdmbC1VnPUPZOG9AEqx6PE1f
gUPoVSd1Av51ym8tFkY2nxQJeMCV6Saxg4JBNumXKqiDm5SU1K09BXrjWv5BumZ/UbgqhuggiXn1
eQTrsiyaO1+o6AuCW3Vp1y237hF0QoJV+Xh5y+dPkpFs2HJfRCWcOk2+MCoCjPVfZATaw8Wmf0GM
nbVpnOpOL5xcVpNlVdvAyVJ3yxo+4x1H0E1EYpSS+t0Xawtiasuxti0+i0WPzjpe2KS9sqhCMKoE
MepEWTdBbOvHsvG0u3areeQU38e5WEMtWPgXoxvcYHCg0p5xP/NWKIG4YVNC4WQNRGcFMMDddxyd
ELQfK6+hh+/tpWkr8dRPenyoLZIP15CGpL2JG8v/bJWLIDM5m4IDoIw6OAeTnGavS+UFAYphDvpj
oHLnAHKtmbbgnpTecV7+VugBkaipx+uhFDj1hsb/bvrZ8KzTwtTn0+KjDq0sSVHJ57R/pMTMpM/P
0WsH5GG+V3CDkbjaKfaYZowfjbasz3LOtddUP6Jdg+3XWBPWaMqDI5vcW5uI0vfj1EqBxEWm9PDo
7KjQjmeIHBnt6DNDCjJKRjoTF2VfmtlmoQyXkz3sONsAOkSYVo38hs+r2UWg3ccNeAaN0psT1Xr0
IurdYEjf3KOLnWhaezMF6K/XGuZ9vuWOuoybFpOhONTuODAtfHu+oLqD/wfiB1JTtswCt+pgENZu
WsTIIZd5mFqBD6HsQGSk+LdWnkrV176z5JlOwE31nnuXRv0Qtv1ofDW1Qvcyk7GqFme6S4izpbsw
YVypFUHIyobzn6XZjVUsSJlHh2ZIW3qXvSGmO6/DAMov5TZmqPzZZbmHRRHPOLKwVDKXLSf/NPsE
2OHBqDfsrVlMCHMQbxY5z5dN12DNCag1RusqS2GPVG1261bIOVJdEk+XzMI219y7imvXSHO9nqJK
muiiI8qDuaVmhwPB5Hhn/ZIs5m1bBAPFt6abi3NKHhhn8tQmsjSdeuAlHCIM566tdRVfG1FNhP2G
kTWqFJV9Itw3oZa+fO1jlcktde+mK0LiaLCVtm6zVJ+JhnV9Ejlz0qaQX+ZT9NTJ3id4d2jcyMBO
NCR9gOiqTOJdkXm5vNbcyMWBpN8cExJqdBUSo4OVIrGHedn4ZCO6b0knvQtk8/73Meuy4Mvk60gS
Rt2xOG0q7bjtxRAp75rrg8ge8mB0O1DXWaoPovIzf5v0iP4vIy630Y2M8MJuC64O42EZWSi3C9nT
KAViJb+VXJgbzIoZgmdaAssKAbrKSBfxuN5OqzrDjRTO0o4ssok9/vvgUIq6SVRWF7hgB6Pf8N3d
1iUd3NrE/dCdizHp0u2o2Gpum9EbyBfObRXtTGaTvIRL1IGMyPNZ7CVxo8meIpHyzgsA+xgHMWRk
BPj2ixXdGr7ky2nvG36Iw0TEO8qF83CIA62669noCMl2/DyZdxkR9sY2T8xS7TttG8Y1MfOB2i2c
YeCaz9qu9oGY3OiiMI8qz5a7lPngIpxj2S2zHttFmwnarh5XxetgmfjepVuo1v4f7c1+Y05etAI4
Nl+QP1pyQhYvAdjOM21GAaaFBFpo6Ee6uqg4Q/mYZC173DrJZM9YXpDSII5U7rWe1HgRYWTFa2ZT
AGyYntxQiv0ioh1npHlZxc6UrtNqwPRI7kyc6Ru78j5TtRypdcb1LTVlmBrad3AtHA+Ac73zit6j
C7kset/HkRWapG7fFqkqt4ywJ39BWGgRxrhOzHjY+4vTPpdwiA4Uht3PSuselmOeAEo3UARGlFe2
BUkYdKDKb01E3pavus3Q+k8MP41PFKKj3XXRanAhl8pgqDYcwTCQJGWAYTa3V0tOLEnCwrpOiuSx
XTh+DFlNGFxj6PXYGeSzikXB5YqTXYLYfk+wCxdjwXms7IJVno877XjupvMB/9Zy4Ycrc14RwdBv
KJNb11I30XoQOSZXYlgTzs3tHBykhv26Sm0zp86Sk+yGnG/jl1b6op3EP+KLmPY5uhKaeXQyzcul
XeDrFN65MWj8KE6lNsLApdfYxa325UvqFrggFAv+DU4JazeYcX5wgSUdkrm277vcrb/PcEc/aa5p
LWHOqrguFp+drJGsZnXVX1p93zwjVejWpraLA6d+Ulprvu7LCONgn8jSCRUz7DxOm+m7XwZQdKRm
mrtpTuBybbmvSTZcDMtUfC6GLn4casMNuX94X50o815NlVLF5Ok+eZpTyKCT9A7QFS6OyRo+WVYx
b1q6RgiG6nKjwKdR/B+CtW/E7ZZRgoejJr0XUW2266zGZElrRpKc7SC+NXq33ms3fRO4Ng5pM185
1BiJdPcerDKpQys3WLib1KQ2CqYgmKLvYhizA/ZQn9Q7P8MIVl03tvo2145L2Zn8tmWRj73r4MvD
PxgmI+d3o2ui88Fr62tPTS8c8o01/ieqIEzDVYVR6Dr1Z+ypAFe70PP6G05kr4opvKqjgL1oyq4L
OjorjizjFilA+bRUeVvi5LG6TZ3WzV3epTSq02wqbpdqvrH6JeIa15ubxRjrg+pjIxQFbdQqMq0Q
Xqm1Lp38LoNUuoqaoG3DiAm8IxOlfhly83bpHOKp54c5z/cEHdIA6aonw2ur80y5+9Qy4z2gmn2S
OeNzaU3LZdrPZ9E0LBvYlNFKJLXYRQQfnQ9TW12q0p/OLEkFaOSke2hA81+CA5tw10prF+DkRHXa
bePGt96aAGyrRvB7rArjJXAbtz94Tvs1beloNdS9zrwGIo8/VXuS7ZH4dkGxNRtOX5kIdgN9tjAe
rCkc3Hhc29p9YkUdnvt6PBPFEB3SvB3WsNDcYdM3wqNhkOl9F0BMKNBbk6VbUHCEbkdd1pIjPNrB
uYLHmcPudYgP404lyjPucmUSWswXWBCRm547UeR+clyGbQ09ZR84CiPaUDzWZsYO20YWeZ3gV6nY
qJCOU0msEaJ7/MGIqWT50MbuU9wyMvO0m0KoayzmnvWo7EVgTk+Pd7iMHnlazBTIUu2nG+60j1Zh
wb3FD5cfYV1auIoEG+b3kJbyQpS98S2IJmNlEX29rkeP3N2keqhzXunU0wFbW5T2wJ9p+8wdMp+q
SxM/Io7lJDj1epsend+oyJp1mrjqeaClCHFunni6BMDUGf03rpKZvHG0HncdJt0FaAw59msiw75x
NeXkYZO3O+UskCyGmL4WlvazkXIwgq3yos+j5rPV1uR5x9Sys2hiUvpNufewnLJjeMa0MWPpstz3
OxDSKRflrhMhPcN53JRjetErtz+jXgirNukRjRT6ZgbNd847LN9IWY4oOZRcWcw0eYD3oC/GrMjv
k4qjBzG+3ArWdjl+PZaLvxOy7oUVDMIHe8Yo3XOzoopCMylURYJrzXR6fq5ljOKyrRmxBxQOXyaq
ygdcKBVg/bHQ7aabJvNygCm1dekkhtAXXxPbCJawN9oo20TI+J2QWHNQB3YpAFOMnu2cTVnbPWLm
rc8r/Jfr1E/qG1rdJcnGqcdRnbIaOOAxwF2dGi8UMzhMG5gQCUCAe9AVDwsokK0Dl3zdNek3f5Zx
SIHqxiqDm+6Y3348MZI4vORLmKGNCzEgUNXOSXcTGdzIVYt5j7NIY4cmTMM0Q6al6E1EG0DPTcyp
qc2hFwjk2mu7rrtVCxNyk7lo4CVtNU63yr4aaMRSDBJ6O6Q9FaIJaXeHtpOWc1uP23mxWX2yAiRB
Pc/zNjELc18K0mN0YBVvPca8jIBryvDmfJ5qy7hipXZ3GH074DfaCFs/Mu9d4XRcaOCx/6A2+G8/
/0fg0GnzHsoQfm7Qhig+hIX66GdBSqPi0XBKYGm5PcCu4wR8DJnmkP4vvUWAmsjRAVxv4ebCinKq
941GCbQtUhl+i1I0Z8pN7el8BtdhvqNNO0qlftCm8TPQg3sW0l3LlDiATqRUkT+PWY13mPiFYvQ2
1eB1ECtUED0PFWfIMOChcgyTQXJvxa4c/lSy/MmW/cUDPdXWHL+fFADHdtBlIpI7zb0bG8T8lRuk
m7Q0REF+SMX1TKaoGERCPMLWN0CaPCGmyIZLk3Mkts6aioNoZBTSXTeSiziozeDS6not/9SZ/SuZ
zf3/j07Eo+Du9+iyu7fyLX4pftLfHP/Fn/obw7L+wwwx0XlQUsal5KIg+1OAY1jef6QNu/c4qP+A
m6HN+S++jCxtXIigpZHUEV9AgfUvDY5l/8exYI0dwyLQ8qMK/Tc2xJ9Vdbin8Eaix0fNxaaNteyo
f/tBH1mhrZ6got64qWE9ufAfHnD4jYhiJwCqa9H5EzBDL3pnnKMg+mGa/fmtLlpFvJR08UDj/vyt
1P1maOrBDV1IF/e8Su8aDqbvxNX98ktwrB0zVTAB+Sc/Dfd548edf5PHQjzNXqvv87iZ5tUPL/sX
U/ZngemfP+WohuKx8DWmd/JTej9qyNTwb1SfFDZN2ljclDhnLiixfjJL7x3E28mK+8fr8iyTEYXJ
0iHI7OcHl2fW6C29d2PlVnNOEeMuBqh8oXuQV//8s3718H74olMDpFsGdk/L7mYkLz3EbeGuzJaO
2j9/ya8GHxYOZM3sIBzrT96QG+tBJYl7oyI/uOV/ooE94Zc4K4DqbeHjFcVagNp/Z40/MXf+95V5
thUcCYFI3E6+tsiWFJqaDwdZ+pd9PlEdXKILZDr6vOmEwAUune1SBfld3wbRpsQr+yh97W6lo+LX
NHa57Tv0QVayWMQ5rQmf01lhRWFRsnW88yJ++Yyo/jmoLhF9mqfjq20RMB+b/n2jyb6AerYmlcGj
puin321nCa5rOsP7f34xv3j7gFXQmx7DoUn/OXlCc58kIhntmynrrDO7BSC00Ff79/PTR5p4DP1j
acRd+vNYbo12SObevAF4AO4lgqqatv17HlGaEP9rrfHA+uO2Zsb4CKRPfkudxFlLQQ6Wx0DbopVy
fAoyv6jOCBDxqzD1AxjEdOm8HkWH1Wcb6swDN7fGsXpotmbzHYVixHFOlcOIcUrUoM1KXgnlWu2p
MGuT6IJinx+EYzUhPUyXwL2lZVLMKxzqEaCikpMheO8Jn24AoM1zVf3QCuVSi56a9nsyIHpb4Y+l
oA/XWdOFXSYaALZRO48TQj6oUfAo7juaUWtfkTSJ2cTpNrHZW+Bf0lTbISb4ZQN+u7QAqAA2iI3R
uaknH9hLWaX5i7Sy9KhOOsLEKs+1dn7jOA8R/Vh/NRuBc9s6jTNt6fY5sKKtVt1k1LIWJIi1Y6/m
EbXCSnMM+8Jlm7gSuCEmXNmmVu260bWv1tWc8r9QEO/eRFI2BpXWzvga9/b0vc0ycfDLzstCOUo5
HEEsyR3PMTjYyB2CA5X+QKyZYvG529DEOlRz0t2bDrWibVx20QF9ymisa02zDXlaQowPZfEx2ZWV
NVQhPZf8ux9zeVzFhmXHm7TplurC5tbA5Y+lbIbEJil8xLo13ugyoAYhNkHuAxef61nUi9HfotC0
v5RcSieSfqalCkVjOO6q9ZNjJYuq+J2TyuY6VnHzqVJ8wzrLveK+zFxwVxU6rgf2lnjHp5v0ESi8
P/vG2F/4PvlWYePk7fUC7+68MYP4JaFcjxovS0pr57ZT/lRSuc6og8oBnYmY0M/5GviKPdSAMkD7
jJRHKTDVofKCMQ+TYKwBPZt0+2vXNQya8EcRlXTj8iW1BgBsjpECqrCWsX6lmetB6J1l9clyRUcf
LJ+glfRB4gC9yjxwIPOSA78aJpzjZJjSX43Ldv6KFLeHPqNh7DrTUa5X9zTKlyRDBoXfJ4KP1IxO
E9KsjT5VOdEyl6jij1UxOVZj6Of+eNeleXdB38n5jmHQna9zaY3nNjoEYicdtGRlb4MRz0twyKti
ThaYJL1VQAJbAngkZSEj1C5k1RvbTC4FKH1BbYw6Ycu1dlCIcyBo9+ZtYyF4p8rRHp1dwwh3htsk
4OI5niBtx2bifR/90uxXzeC7W0ObzBvdgPZif6HlFxaNiewvcvrpazpZ4gFhpf4yciu882jH52QV
uLO7tsl3ehnBfT4IT8mb3FnS12BS/hCmItBtiF4xP1SYiNQhAKz0qZmYejtkahAXVQUAmd9av4Kw
5gXR8FGvphnFz/wFdNG4aNBFK8EKDDbZcqFvVcGXoHAiCQKqJQ+oDjoFmWzp5+eo7BYKmzxbCEJY
uXKYDqZ5WeRm+yUVy0iRalLZ28xryCjHlMM9LOfqq5sb0bNfAhlcVbSrvtTaEp8n58jAzIOsvMqQ
xpgrM8iJDJFVRQyOLdgJ6fVl07VvSLhERumlz5GRJJe2thMETkYkXTRuS+JSgF7akbo+GGo0FE6N
WT725EMlhuHexJwwrCYTjY3OjJgCCJYLylj1wi+YGrrLMYXozxYl+BtEmUVOV01jz1msPk8hjQZH
EiM5d5fIXLnueJT+sfvrAVxXHpWxT8RJDFknl6n1HdGFRAvKsjyFc6sp1bOBpd0qse3xuqvj4mas
5plmkTSsC+wmEn3y0Dnw5aTdzKvJOIrFdVHmI49pKG5yxr1Pt7IuSuSBggbNqGB5xd0xjQJSojgb
sjE/EL/tHfEwQI2+qL6t8MQIO0UpiWnLYgVqqjIICGGspEov/JYYvxV+nqXsVvUoaYbQYGtH506q
Fr1ORUX4U9eKjmKX4SQqNKgT2GdGgMjpUhd5ZoQ06pi5srZRmdNRK+GaMyumFRTZmgERLM1xs4tb
lk0bbL8/LmlBXrtnn1tO6n0vqz4QGxSNqBudsY7X+PMrNKEC0c1I1FSxl+lgnhM0aU8r04nd5/YY
KC9q0wdPtLhDiQ/cNb4NuaGpPkeB3GqCPrtNlZlgE+jjXZvUat+MRFpvHMPFAj8j5dUTOJeMhz6K
YdUblQbFZDS+uKntJCk3DtB40/rsp9q8b+YmK8J6JgFs3yDj6Wj/pTmZ9w4sXxrf7TyRJKVmGm5T
IeMt1B/nm5wyfCZUXPNp7+IkAglGmwOXzhiZE+jyOjc2rt96nwo9xR4y+CKzYCfSwF+bAZq9zUCq
PKA2JZrHLOs8qJVdoB4j05+poIOV6M6jgOETYt1moyzFcWQJt5EBqnFE/CvhJJEbAlC3aXiX7st0
LBJtIhuJ/1rkdCHWQUz7nvZgB/xQzkCutpNQM1t8p1H8OG5eGxszEwkasb53GYrmRKcNakL01ZkE
NlmI7uUqiVrmjtWyEW05ehTRZsbQjvabABJnTexXCToLjUZEH9cBzibTEfVMPixA4YO+Giw6eTZd
AdxqABPHlFG/8fKop5blyByIkiriZp0hDsde1Ea6uTTtiWKztkaf5oOu2Kncwp+zfRqVrnFhoudJ
zia2gmBDZT6bDkpXziOUFf+AnFQNYQfO8YlCmUIHb87IxmXu+aho41RH5HbAHL5XmDfK+mqxGvpI
iirvzQLg6YvdjFA3hBbjVU6+3QL90SmIO/McqPwrSkMAyJoGFRcZClwdVrRxjCt0vdZM4IEDewQP
OQcHZxwUjzMaBJliNLbVmt2oz9YNyiOiDjxB4Jt2juFv0MnIXWmPmXBT70C8taMj7hJum7+z0X5M
10SBEmrGzZ1gOYO8JWM/Wpm6c/9MnZtHz1ijJTnG0WlE7MNZK00zeQBdk1M8lAu9RwzXMbxcNpFy
W4DnRC/JxBBhbXbsavqPCLzB/yMPLxkjG8OqFRCU18B9IDUvaMieXtlLV0/5trdML7+aAQpUU16e
DXFlDIcJORfNuwBZ53qMbTr1IovrN82DpsUuE0roRBrJap0aU01FV8gC4W4/Wxd97WbICDmp9GvO
wPjKO1XHarWgVETc2C3uFZ1dulEqWgowzEEW4MQ76te4c4lkhwpObiY/Me4nib7oXLnD0B3qLMiH
cCnS7KlP4fD+aUT8V8Wp/zc9YNQvfri8/S8P2OVL8TLjq/mx/vTHP/m/8PzgP7ZnOVR3BJzFP/D0
f5afguA/sNIpjjAHYXJChvir+uT9hxqoxC9rY9j+I3jqr+oTiVQSCDfFJ9PGJQZ9/18lSJ1QDIhR
E2S+ghY68TJy3kmKhf7+weiqdD+Xs9esIsNQt97cj+cdQfZEHAnbeHQnuIxQULl0yBpF9hL71g2j
rTpz0CBcGJnjH4qxYaVXjpoiTCCdfUlz1AcPrMdDYiJuJjdClbQhWnah44qdHkaP08EPj/0XhaBj
Se6HotbfP+V4mf6hhBaA/uR+26O2KWbNcS3zmWZEcgyUb9G7bI4O2pQARdfow9zR8iJu6wYVlI8X
ODzyn9+qNPU/40Nr+lXfTPSU2HoixPwBR+pISft5NHz/UzDN/hfedbFLUGEcVfWTevGXJUU0Pqjm
eR6hiPdUqR/7wRcXxOR6Z//8E4/Vpb+r43//wpM6/zh22kR4IQ9I9OGGCdLqvtqiJCsqy2zjle54
8SiXxauQGAc+sL+o9t4rSP1c+fr7u0+u75Msu2b0q+XgOAvaC44Hz02A8Yqbc2O8U2v5uZb393ec
VCIio56kq8eFweVMXz1nLl/T1jDvvFkm50GVTu8l3tvHT/zVkzzxS5eZ56TZcLTS8PS+I1D2b0lG
NzGL2DB25sGb9zV6E/hp5ggZFF3XVU73vAI5HJsPftCYD9bQ+6+chVFrNHnNXbMTAY2R2kaebph6
xj7kW99oUiImIUG5eucZ/Vwa+usZncbaVyYlIbJYgUSmcocn7kxY5r8qCP390ceJ9cME6tsRFB5n
xx375opkzb2V1++M3N/91SfVs7xrOaKNfbeL7ObKMpNbs48/+EBOnOFB0jhZ4jT81ToP1dyETsUi
/Vcf4Rcryu/+6JO10RMzGd8un5yTrJUsRNeW7eZjH326Vrmod4Squp0NKh3d77ow+/BjH32ySOT2
ZC9wY7qdzE0agdlR6vhOvfh3D+RkDVAlUsTAkXrHsQcNbfbWRuKDD+Rk6lO66paySrpd5QevFe7+
2G3+VZf072F9Oten0ReZcxzWxhysjnd7mPRYm++npoy/f+ihn+IQpx4Xd6T4ji4ZCKOVoglenGBU
H3un3snMLLLBcqGgdDs1B9TCJjQ+Y2NVH3utp62TkvhRYeXUeRB4rglE2HRts/vYczmZnLoQSg/0
3HdYKsI4hgG8iObuY599Mj01AgiLi3O382x9p2oZZuaw/dhHn0xPv6yocpRph9ARWYUZr7XRvvOw
jyveL3ae01494R+DozvFokJp+jFSubXnJhBwdx+WMy+W2W1MyewdfM1vJqx3MmExAXJHX5hVI/Xh
xYrDdBbv/I7fffTJhBU9CaB2HPOI4Gdj5t5ZSfrB0X4yYXG+C6oprd4l6Dp8zC+ALT/0Xk/R96qO
qAW1Wu9MxyMQengCzHT1zx99HNG/eK+nioU5ERHUQQgbBI5IxN/yGEkelYcUktYaAZax/+fv+c1z
P15KftykM3s4UgQi1uAZpLcbSUrISI0+9laPTfIfPx3AqKtEwFu1m+Tejd7G0rj+2N99MlujIMa+
YQewW+x2Jr11elQDsPCPffjxYf1wciEIp1C0PPQOGzHarnpXCO9jS4Hr/PzRCRUcJMSN3lE6aFdp
jUEiHZb4g8/7ZIJaZEzMkC31zl3887yedoURfPCZnEzQCb8RtYTjQJFet3ZdGm2YmD/44SdTNBn7
gpJIx0QKaCO5PTG7/cdOofKkta5jMpSGoQdoa6nPpK68QoH92NM+BTA2WtrlMk16Z8tqBY5x3drv
4Vx/My3lybQkjqcSFOD0Dh/oprafiSL42ACUJ1OyIoEK0wlrFvH1B9f0N3q+fWfW/ObGLE/mpKF8
h9YIY3twPAdfIuB2xTl3PdJGvzFnJ7jQ6DMDwnYavJ54J8QVqSTZ3utiJIB6HvJ+VVqxfOr9yX9O
EN3BYXGdMCcL8LryFFaQPK29F8Kpjds0D9y9MbnZg6nxjAcpVW4JomSyguFANJQRxtKRW3AOxa4f
GoJpE1Aaq9S01LfWFmqr8xk7j+3BLzIWIjUdKWDIjZV7sHTWH02lPl4eX5ONltW2dz9RbCSLpDBv
jdmtupXpG92t3fVZt9JYZj92wjllMoOBgu0wsFl1pJNGRUmojfvB4Xqy9BCqqqh9MhPqwL+NKvPW
jOwPfvTJuuMsowEZjOEapYfcJkezKj62xcqTZcct4oj+OJ8Mpp+OTtq/Jp75wWd9suogL1cuzV69
wzsdrCydw92K+rt3ZgML+i828FOMML2badEmlxunis4rkZ5VdvSxPVucHN8X7Eq4lUvGSA95UQs/
C3Mrjz92dRInS0+ylD6gJGaxt9jIWudzEI4fGybiZO3R7EoBdT9eZu+sXcNa2/H0sWXtNLkyofud
V4VNtBg88mlywxEy7D+/yRMg3183vlNssgH7vEHJqndTMCcvVMfxj5HvHiZLFNwXrAV0bxYf70WR
6TOVcZtyzKj54DNzfj4wTLrNln7IWK8Teuymg9nEmJ3iY7vjqVQr08Rbe9Q3OXZjnp+IGPngxD1N
LWXPTWaifnghuthXC3EosfPBd30yb9OecMVSMYwIj7o3S4Kh0nT82ANxTo4LuI7yvsjZ0yG6XB1h
R/S7PraUnfIcMX+3UxZVelfa7TV9tY3Rsrf88xj9zXnhVHmpNCHS8vhnT0MDMuDMat4+9sEnU9b3
sJh1EkaiFQDkAoq/vFsC/t3ffHJcILoHXzM0o53OLqEcAIDT7yxhxz/uF2uvc/zGH87vlmVg8ylF
d3DQJ2xg1WBlmbUidsaZrmqniD92H3ZO5iZOwgXVEm/UT7SzyqPhxs+W917pH0q2X/2Kk02VgPEa
PlTM3FwWd5N707KhthJR30sVSCiyeex6Ns/asvXOJpxF216iLZ/xm38XQeN+bLMhHeWnZ1mjJMFa
i+eaCXGJ1RL1evrub/zdEDidyU5dj5XJTrYU2K6xd9ZW8s4F+o8Egl88vlNNbZyj8hQW+1g35gpM
dpEVn6opsdfE+0b4eVzHXC1uTWKbe+wcjQizGjq+B1QKwf9wdl7LbSPbAv0iVCGHVxDMoiRbweEF
5SAjh26gkb7+LrruPcfDMaW6ep3yUCTQ2OjeYa0H4Q7yy0yT2UG0QRfR7BzcexqgiJF6O/SHSax0
q2zWi52YN+Avx2Plyfh9D/OlKWKptTGvFRwjo630A+MQMfTBzove80TDifznDYVi2BUF3adbFzVb
TI+mM+pvBObzk/vvS+7+C2s8KoxxrS+2SH/9B5uumUNau9Y3AZznXd/e+12t++PRnv3cFF7FXWVi
M2Krj9PurQfuymK8BEmXwDhgJ7EdRNuL+PUrZYD33dDfrPQ/v3SWFr3r8MKqeoCFw5wjc+v7N/LR
1772RRg16I1k0r3gqNi5J32pH2yf/r73rBWMRv9cK8wHlVAVeT4xBNKE0tdbt3N/vu+zL4InfShm
bs88TbwCDkPMcALNdek7v7h58cWdFNfp1IImofH0sadvZ5VRe3sjJl40If9nR/i7DvjHDRVzUOXU
49QeJJINcrqAZaq0L7OvB5vOVOA2JnJocV7oR1WZ3V1m0ZGhNwEaXbj4R+pLjGLnmb8zJt04wnOi
nTd2892cIz563+W9DK2Uan3hzGo/t9LaMvNXrGZeWG9c3/Nh4N9PunepmYnlGLtuC3p7XryJKVAH
Bgjsybve8TMaBM1mAeXQm2+8z6/9tYsDTwVWsptz3aS7plO3APfcm2DK7NNs+N0pda1ziXT0ptt3
XblLo8ecZq0mwTRsba/xD6YagkjF3KHXP/3vMfJfgrCYgqs7oKbal0HZbgUwmD39mTKaBwzwr/+J
KxHBuIgIKSMdXT34Bp3sjgj7qviZDfX7os1vp9QfK98ZXYXshGOtk87Q8trPcVO8r6j7e4juj4/W
2iFos5ojnIYuRX8x53dejotY4ARzQ20UR8hcV1/ZARa36NT9d16Pi+1Rv/RTPXfK2tY8uX2PcNhL
6ct73428fIar0aFAx+msaloaFOk6y/9/4rX/RLBLQHO+1LIdnJRGnRqJaKiT9H8Y6IR/X2rl7O/7
cwcemFPsYkFlmSTm7cihKhItVqjXL8vvxfaX6HM5PCPLHjKSnltbqwzyvedy2PZ9laxVYxqHgmZX
8o599iNnV/wghJtta+lrx6Bm/GgaR23dAds58KqM37l10C9OSVan13BAS4vBb1qF3IEuxiTt96//
3CsRQ794nBOoO01g5iAoZMMsRpoM6oOnFv3Zt7Py6fW/cSXC6udQ8sezZyVVM9AiLfe1CSZPOKL8
eN7ffrRpMl3bwANoPzHlw+t/7Ep8YtLxH3/MMWaMuH1ibWeZPEE12sZ98cZHXzn5XU441ZNDw+jo
mlue8GBLx6Mdmnp+ayxZAr2NSP6+X3Dx1Fvm4sCSts1tadm/dKeCj1i/Kwr+y5sTm/0yC9xh2wDP
xB56zkKLKAbb17/476Ppvx8dxDz/vPaFPYJELRaxbSbLdW7ywdWeqoYGUBo76UdKc1M+B3Fm3XPk
y260YfHxiuNDwqNuW/dy8cr6PB83n4Zp7n4Zsao3c5zIW5VW+h3v4HpD7rDa++yG8jRIN5WPO4LS
tFiVeZ8mG2XXKbK02bpROUDy2g2ajV1NzacOQN4qp/Phk14YOnjPwhVv/Oi/rzf3simxdSpNzHkC
FxZOz9YEnRyn5vs6TRhj/+cFraWTLSmwcIaW6NMe08wNzdh7q7z/e9Pxt/t18ayoMUj9GVDqnlqw
eyjoCF3ntiiOsyzTLUAzAgJMIlqcnWSJl9BfYvODltQMjdWiO0IP0pbIZGtZ3xiGhfk3tQyAm0td
b3K31t/XyeNeJrtzO8smCFH9VoM4fBOk595FdNNvvEz+HgDdy3y3PcKq03QQQcLQjC0QZlAvtdls
cNy/1Sp4bYlc7BGWsTRn5kfFVvCn1l3JDBWAMvnOBXgRLvosb6FjpebWEnn2MdUCdQQt+VYW6u+x
m/nyf67AFEpor1WJufWyYNosXWvdpx2h3BUxo9iT8J6sqas/vR5ArtyLy35Bmzw4woFg2QN6yT8N
gTUey1lMAAuI56//ifMe4S9L/tzA/Oe7SG8ykMqlsezzQrOP/ejhgzan/LHT7XLfjhOHc/wtqxQB
+ur1v3jlCvrn//7H2w8Xmjn0YHz2nTyLwkQxdjjTp9Zan3tSD3PVLI+WRw/DW+vhfGv+9hMvonCu
GJRSg7vsGZuE7xzX0gZSqGd7RiKCPKKcGK+N0kwOmUUJUA2Y91o1xKsWv+i2shlP9oq+WWcoIqNm
LGsuRv4yAhFKwzIbqrVeVNWXZGRqtEF5dTt4rRg3ut11N2exwrONB/HOHDoPuCBCivtAxskd8wnl
CtS5v2FzVZzmPqm7cJExIoDZHVdur+mrgMm7dZplX3ulNZE1KueUl3Gwef02XDlWM9z7z/vQaGnM
8OPA4vJ5+lYMCya/pLY4emhXqfaVpyjZ1xI6yJgp88WGJn1yx6V/SNugeNZGt71n2sgN3Rju+ziN
8zqDY6etIJ2lv3pVTW/dvit37yLk5y0QgMHlaO2eD78UP091ZSRv7Pb+voNx/YuADwmm4eg2qL0S
CcKOybdOiWX3X1ubWTDTBI37+sW+EvEuMQpyHnBKxJPaQ7TEAAr1LYKe9lYm8NqnX0Q8p8+hB02l
2ieGPQOPYqaypNkZ5tjr3/5ajLiIeaNZmEGjOrVvDM1kuq+z9du+laBYZ+S6ZWM162kJZlJK5vzW
NuKcIP3LQ3vZlNmOvSWSWql9rXnFd8tIa7hFDVasqWEasarK4EfR4Z9baaKKj3PdJv8/A+7/Hdbc
y37NmPZSPBD6vG91oJDCPWlgA99YzBc6v/9++EXwY5JITBD11J5xrpjRIhg0xz4W5Q+7VdWGwWgc
nEoP4kgHt7gFruWcmE8av8EDpMni9dt5ZblcgoDQFo62n+k1yLX083B2v1DW69/6heaVG3cRVoLY
H6xEeP0eZRCJXas45qDszaj1DSopsrPLnSszeYyHXDLK3tWRYzU0fdXo+AB69uMbr5lrmznv/PP/
eM+w401T6D41UP5eWzN/YOyY8J7ZdtNLEs3MwezqJm9xjrRE6vOU32DNzaZLEaYwHlBG1cjAVqLx
NSn691HVpWNYenPyRvHzysv9spnUoumwbiHnbRNfYtG0+iLCwN2Fo4lO8/U7fYFE+u9yO9+kP65B
3/WtOdfZsB+ZSvwEPtPsAWw4XASnZrYVFrB/sGb6PPIZge96HIDLbfD7LQBQU26KGuC2TnQIvTUB
cfUBuIhVZcGkbpdSLRxEtrxIN0ifmaMy8lDJaYzspPmYkjmKQMGpVW3mLdOcY+XIUIsh27+xNK7E
M+8intVdQTZGpjMc6s8G+P0inld2y3yv993sve3Y12+ULK9sdS5bVrshZp7Xso1dsWAFWZQCEVvo
EBzdZMVwc7b2mix5I0hfWU6XPawJAna39TtjZxZzvxH+MoKA0Xh7q354YzldeVtetq8i4SX/Zkt9
N5ngSwGhLlCn/efKoRODCmm8fn3VXolPl32sC6hHCXui2uYzU7iTWsE1fiM6Xfvoi+DklRLO9MBH
I6mIAmOPKOyNNXXtk8///Y8nzVdqlsto4zbwG7nHJ1aATwDh/folubaQrH9+Op3CzDhnc7n1DRPw
QeGeR8gyKe1bEvLzLilxpK0rr/35+p+7Fjfci7iR2rK1qlyUW6rP7raDSfoznkb57LrsXLBux9sA
feEqGzP6QfiXcl9OVr5lML+LBqjqMTQE1GWvf5trK/siZDCD64NilONWs7PQ6xeiRIks7q16x5WO
I/fSvwm7vVpShpPBg1jaJh3P227Ll0MQTlUi4VdOWbvVVR3fa5zii03by+FXKhwYEa//wCuDnO5l
22w500RBwhSg59hE2JoMxMzgRjzGxuN5Hbh3ZVKupajvrHHe0yS5pnS1CUAqOnMcmV7yi3Qorgnt
2OtrD7BLWTP+GXeIf1z0ke4BovobGfgrC/GyC9cCj4K4rUHuATs8Yva7YVYzc2rq2lkLEnyZb30X
icYbt/7a6+KyNTfTraFoF1luA7v0uwiauP7DHK3mh7YkPSdIhg1WCGycH07gLT+NEbsAtgKApQdj
6OQbYfx3Ufovm9HLNt7St4Fx65AKZxfBauigXDgg7smjeHDy7xx7ki0UHGNPv120BCqqvWU7oigM
gfgkO69QgDx6aAmhZpv5GsALbFk8PUloJ7nYwPmwnlBMnyfgOIoWkwLYIhDhPvfaFD/ks04uUJ+M
F6eB8xG9vuauvAMvGw8l69lHWUOaJ+mqu7xqvY2lAIaEHY6om0Ep56DbcbUq3XF8o9R35Tm+bEjU
tA6Hlasx0LL4MD0TBIDhwGTqMYEd8PH1n3Xlb1x2RbcNc/tNO6utsDmanJE+67zJ7ciYEfG8/ieu
vAUvm4YFzhhXooTdumLIotQx1X5xyuLGm1KA/X6bvRGEz2+Ovy26i5hfDo5eF3GqtkXifOtnO/mS
TcJ/et+PuAjwxdLnLXKYYatXVnZI+hp2kOM1asvgVHlvd3P/xk2/9isugvdUxcDBqb5uA6/bkISI
uiJfv/4brn30xTYuqFEbxHlSbTPdjYqBt+D/0jqvokSv3OLL/laicI1YPe635eLFu6UsnVPmNAlg
n8nRdkUF++utAHclOXXZ7gquJE46xUiwHLrGBAaklnUPT/IIJ7ddz7H0IlU3O2oUB7/9lEKkid51
9eyL5RWjJ44DT1Z0K0z6PsMuuoOMvrzv3ly2usb22AnyNTW3XdwuovyW6/O3933xixVVa07muvVQ
b8eks3hjTvpB5fKtG3JlUdkXiyoRbQOuXeNw7BjtSpaZTXNz+un1r34lOl32u4L1iccs5ciXJYN3
WmzY7klnOw+isIyvr/8J9/eG/y9x47Lz1dNGtuIu597cqKiPLFau0lWTGfOmzd1in8JMeY7Loljr
o13fIvDJj0WiBAopBjUiY+zHT5AjVJg9WXCRSUpa2h1ksgx+e9p81f0CmVsRVDjiir4IrUzzN+Wo
9y85JpBblELsqj2VfdPbOdgIFwAdLJlgeWHYgpJXlrMg1hbHcMRVjNfroVUqLRKONvzMZ3AwtuUM
n4rUmj6YCVA2nRdmBDwLTrqM53yVNAI7k5Za20SZsCWhtTPMUi67jsxdJz5Bh9FDrGDpnT8hDovr
Gi8cAjDwR7YA2EPacrnFgWOwIB+HZcaWhveN0jQMR/kpC1SmQiOei6MCrdiGo5PD7un5KruU9O8t
R4d6hV6ieCqbJr7VlnJ6qHWwaRkU1hp90WyvUxp3k1AfB/3BREcR+fQ0PlGyTrdBk2v81qrQ712c
iuO6Se38rgKueHIAYOzirkOloXUYYs9HYp9aJLgLqB6deVykI7vQaTRrh3U43nMo96IAT9cuydNp
XtVJN7+URWoesqq0m1WAas8JMS2OgL3mKnA/OAJX1Tj1FSWXpRb3oL3tH7Ey8mMFrwzTA6MOp2m0
m2RViCF9AtRZggOreIopg5sur1Ts7pFbauhxtbQK2pVvAAvJOxHA5y/do4K4BDZNaSsTQmQbFqZv
4vmqvH6NjAn6+Jg2O1JNkNmENT7mhjiL8ZyW9HvFfBSwLOakGdOrBVLH0mq3wVhOAzXEtsUvUMeL
BYmtz4vIUSqrNnnaNOMjECKsIppvEwI6NIlQ4c6SRyvt5sdzgfCjSZ7QO46dMuYPHj/kJW4H/xsI
eTasNZT1PWfC4bb09LNKErbIVkuH0lg79Jfk4Ko46aoJ5c8qSR1prIRXGEaEjjv7WhZJiePIK9sn
TWjOyTcWewfJu31cJpSUgwnQyphQLbT+mWdIIhv6aV3RHuu6qre3IwfGbwZYpLO+A+NBWMkR7NUC
gDIspYdTFbSZ7gA69+2wkx2MuYFnoqJkUDk7fxLdihO+cewRjgxWaLYJpuKsl9XNyJzUqmknTglQ
O6cyyibIsL8QetYpeYhWhe5UTOkuXaA4xp2tdm1vxeMqT2q5CTQjgZbpDFOehQLO0GYGlrXq8rHd
tK4/3aL3zHZugOCxLVSwqdxpPPTKmv29TQX7DALUDIjEA8qq0Cj97C4DnnwKgIGGbQB5zgq0Dnxd
g4w7RG9S7iYnKDFpTku7iQujy1ZSFtmPDBeYvK1bJqrvplwbgMZOiJBwJtT9evSLHyXDuodSuGZ2
auahlkfTNYT+3PXBLx1lXxXVvCXg4gzxlEadnrl3UwNrSxtn80UAurmTtpvfOSYyldFxKxk2c7Ig
SjC12QhzlQnKkkySP+d9Ie9Ih4kPfH35c0j8fthqlOwfcDeXj85cAvNw/bGB8QSyoWcZILk0ZmPf
5G55rjKJg6MmiSRutATYR5tPXjIDMejAphHMKPQesHnGI+V7/65ph26dVPP0cbA57pCVLNCVs/hW
SZbgiSgD9KsNgPM7R6VUaDuBCRSn6aE0MvRWmRLs3zxxYlQah980DQ+ZNNLVaC/6BxKZ3hotWRra
rVarEAWgi8WPe+DSkLtj9kDcBci8X3RRahvfl+5LiRLwBz0jbLOStPpuNB4xAIsB/FLTrVdDanHe
NKrhTtSNvYndpEF7VCbEfq/wmdRMlmFda608SKOp0Xwu0xHyZvFBt8f6jJFrN1L3gpxWetuYwqKS
txbpHs8R565Gr2gRJ9ihe+YGFvke71KSM7F+1gMuC7ZXVQzxjbT94WcwpDJSDdLiETtMNCaxHgkg
v1XYW3kyAtNqIN51jrtK9Gm463QJkqxp6wcgmiabXyI/fMPJtjZN3lTTqmWkZqu7fWkRCpbik9+o
/lEgKBJ8rUZfWY2fomBEiPKUtn1NyZCIGGZJnN73JeNRIb3Y+ZoHao4Aysj10i3ZLfpxFDok/bwn
Z/TkL6BeS0SVl1ZRbYntfe+2Tmg6GS85Guo1XLjoVCO8QN43U3VWHc74gfdNUS+rxdWCk4Cgh5Ws
zZ57v8JGKwdNrJQ7Nk94lNsDYhenjXRz6QiLqkKt3TQmlnml6DwiWpaZE6okTe8ds3CbSGXwaldO
CpsNcjElqsXByMnoZrXxEqR09Wh2tyDzvJMu+cbpxKtzlZR2fVoK7Fth7nTVfbNYzE/ERnA/GSDU
UiBRbaijq2EHkFlrlBXy1JFHwP+wgH+WA25WDMt6sdXc3P9K9wodI54jf8y+XZzgFEyfsyRXB00V
ybcgjq1tEOTGo1jmYT06yegzRpgzy+AJQI9LPpovuvSSw2ym5ktqY2qx2Vd87Ec3w0Ij7CgozYY0
/mBtJ9dr+03pN/UTJTS5dePe2uGCFRu7MfxtXef+UQbk5n0PCYSYYLn3bN7IL5RwN82yAcAqauF/
CILFGSK7sVkbLqrQcue7DuhPF3qr9tOlgS6agmTqt/m57wtwHFoe5BXFBxxYxZPlx+23iV7PY4Ij
7kGQQ3kipMIVjA0DSWkLf06ExEXCb5kV92nzUjgWUuCBt8+gdwCRezO/yXurjywtyfGiBol7A6B2
xNvZxtODW6TwDDHbyk0pUT9kohw/zOZUbsw8TYBzQ3h9AYNsrRXmDUDc+Vgd64Y9WUiQEslKZg0W
SP5fq0WpbnYf+mw2Ckr3rn5X5HrzXUOT8bnvhPex7zw8w/ix97LTGBCuNfOoYubkoSTOlOtofZTP
aNR8nxwbJojQMqb5KyQmahLIwM5eUsziX3MMSevJSxEu13hg3HD2rBbuY8OKBQYLQ7ic+xi3hHK2
sg1mpqAlMPcxRoiM+OxuImNabxLb1raLqckxhBebtKu0iaet8tzi4MrhWTVghc/V0oEcn9fc1I6X
WzjIaue7bpyBj5be2D/7RCTWKo87By2H06iNbnASzGA4njR280+VzUiV0s36SdhapTYS/XO7KQCO
kyL3shA9EVwAkTLSjDi2zWBAg2zlXQjg2Iq6DsbYarLRlEapinP/MLmOlf9ELpdu2F+RZGoQOB9H
V6scfOx6Podn8U4Z5vayNS2tCbYdT1ezMvHSV9tes4KVCym+WqvAyBc6wbL05AVy2uaUXVigeVpj
k7IG50ADX/1DcyQpNLfVvmfWpKVRUqbsZDUtHk5gn7RIS71igGWrATa2NEOsKpAnUeX4ZbcuaVmD
Dh1jHYZEOYmRt5vTudS202HNrC+dmT1Q9yfAtM7PpAXKhiQXGUiSivHeNdzgKReziZxvatjbTGzV
l8bWGfEmu3qwZ2L50tu0RE40/QGQJwnaD259Y2qG9UmfexV5xDq60Xv9JLizfqj3+LjDvABSuqLM
yXAogNdmpXA6epvEnOmvs/wq2QXVaNzVZVps1eJvEr8rXko5iu04T/Et+0+eJJmrtVPML1D/puAj
DdiuvbPaTlq7NuncbzOSbrWaW3iW2z63UWrLFgjragEOzuXTs+IWP17LdCpFauw0gBz0TQoAftVw
9N4FEyNkqQZ2d1tlbTeA1bYXk91aami3k+qr5DaBJVk7UKzWM/uncR0EwqGbj+lmCKIwVM3KE3LL
zN3yA2MGxunXD5CG5ZxTAH87QZ6Tv3/WMqbeFDwkeHiFxg+bl6Y8onmrbhEhqU1meDNuWFMdHDP1
v6ox76yVaNSwpxTRo+TLOPN0PPaet0z6Cqhou9WQ4CElcxQ1gjLFVCtyg33C7OGDXxVzkrNai9mT
CMa08sQFGfWdqcXQSK04oQZY9MZww4AeDHivLCtqDkD312YMxmJDg3x+nxVN+73QrPgUtKN9VsSj
AA/Tztbw/sYmfUZWv6hHE7PxcxpPSRGVmi+jhjcADOcpAB3fLeO+BoNKh6Rvf44rW//Ag6du6o6z
QZj5tAD1mJN5CAfTv1GTW6AlRBcDhJUoCkNuduf8kI6LRnCHjU2inFRwkVvlBxoIgqdSuuOjRoR5
HN043Xmah2IUbC/toPi/5zwyYofF5bnirLFLTxT8zzvQtsLzBxyaa1yc/21DMv+zcFtgpM1UAYYv
neAXpMcxDpnrc2/MzPa8U8xMxbEZje4rAzIoEjPUwvvZMeePKjUJPolgQwtJ35nitbU0wzcrX8xd
2WT6F0lN5zOQ5H4vUUSlmzYr6qdJdsZXczA5s2ZetrGcWGBwT7QsGgpGoM6RYYQsnoospKnpIIWP
oU90Sy4pVvXjc+03CKEca37miPwcj8wpR4lXFD8CMTh74ffWU+Ur+zbvYBEvmTVzC8sGHWIz46oK
U9nGj+PsOsnKJx6fpjLXqYI4scEIQKNLNrujvRdJYJV4tXTUs83Sko2t9P7oN8b0oLuWjCZm2U4l
Z5QuhKicOyirOOZHjW2dsxuDPgHMLRJX34zBUB9pEaPAwqbgi9On+afZr3Ij1GPX+xqXVm+tZjIh
WM6YZAs1NMLtnmQ+nTBVUGrPntbjGOSmeXTstvr5yGf7dn407aHYovmDg6GUHj9pvckeCXCfuh0o
no3hLBBurGqYIRyXG92YiYV5pWgIs6bPse6UH0RWGMemrOQBu1nXhSjnxZ3GlM5RwTtPVmaGUGHt
VcjVBQMxBV0zXmuGXqIltylKLu59PsVHZxH1Psahe2/ZE0Z1WeAWDNnfZnc08ciHvtSMnTRMLAjI
nu7gdWVPdAn7ihdKwwPWasa8H3PN23S2l32QGXvDaOB0+wUwW3nrubA8C/Z+JC46/7s35s2Dno9Y
0Ya5/OrVFnJ7kF/1IyMX7Rq6qox6N7MUBm1mDVCAcQxkiqHL47AaGxtvmJa0H3y6EH8wzhMfKURn
eSTjurvBKWMcBiDQbE3bciexieJem/0fQRzEj45oe7IB7RKsVTpb+yLzDWNVtJXxOClb3fVGtjwT
UmXoAQH9DHTA+8zbuXs2LRtr67mecA99HCe0nYzmrQbk/ezD1tsuZF/dR4MX2DuN05y5Vrx2A0Zf
6xR/ohKb2XDEhkgOBtmobMjvVVKbvyyELc/0GDoYDc5G5smmgWnVIa9bg3kdvjt5iZhRUmxfV10+
V2HjifnT5Glwv6uUFI2W2jjFFzG9+MLggD+waUMjnBi3vdmbPyd96MK5T5kcL11/qDc91UUkmA5H
fW+Kg6fMzpwfgerLI8gWNwPmIurHxizspwZRKnumSd6Caw+QSwwj32TMgu8oM5tISj87yKX3Ngz3
sQXOfZtEl6zL+MXRC7EAKANu3dBRXu6R+nXFunVqewqpRrofmcNkqwAKb/o1pZq7a41OcVYo7LUg
BX7SClk+5VPmycic++zZJtOerwmD6GCBZcXsNS2SI3FeMnLfWxn8fV1T6BlEY068BfUWMcgoKhTx
sNlGuaHf3T+hd8iybcvRq1sPZAqeZDCZuzw970FAfFsr36w5ajnxbGVsI7L8xkyM5aUXtvNc4DYg
0VMHGdrxvHuwu4oIh0Bw5p8aaFvxVyanDkvGabIx6IUo5Ob9YFXgRKmf4C05w+UjLlF7R8ImQ6Xh
OljD3dxrI3dwS3cNA8V6rMqJFxwy5LOh3ukrI8rHJgF6QZWVT6IF7GS6Z8Fvk8YHxpPq71jr3ZWh
17o8Egwx3Wc9nqgoJn2xnYu6QdDcJdbOr7X+oRZFA2Tayf0dLnEEicHSWPeFbS8bOmrsu7r2qn3Z
duSnmibVMRTN0vjcmPTAhFBPyGcVwRzOjKGtmEuIdx5D8nsrtcyPQN6LmzprOvh6erUvwK9T30mz
m2Ue3d2MTn3j1kVJ37he7Gd44Uep9PZODrqxS/u2LUhm2t63UlD25hlApEoWYKbhoKeRtscHbIbT
UsIpZ6aUcOPTgp4p9gxJFniHxTb91ajZMpIjNkyOYcuDcTbCII7gpVk4fhzObpZ+zV1lZhzuWchK
mUlzlzU16YVUVTpD5a6RbTpL+NkeUEp9y0uN4UaD/Q0JOCqz+dpJpyANY1ma31zcEQeh+/YBnpI6
eIo5qMleknJFCt36XPt8QBNrC8cYdrKRIzzHRjOcTtUGQgL76Moa8Vcu1W1dsXPwDM98ykCXkCBt
TaONWIrBXrA2P1dOwC6jod59qxVCQy3eiGJT0GL7UsbS/Zj1nI30xVg+dKnp7TmUYaMvjHniHjnL
vKcbFLuIKAZ6M4rR9mh4Y7yPY5u4xXhZr9W4JBuhdcbPQYzZfa7542F2S1LVbZ8MdwXP6BdJyni1
IEc+eLRfbRZL1XuE52omUjHrOOkLoCfpc35nsnivV6UVgkPTdz2AZQ67er/uRe+wwx0Y1LOccaNm
kW1BJgSfFN/pQTZ+9xCYNWh9Uzc/19RddkBfxNqdiBt+Ib/5eeE/4RRpwFGXrYjohrDjVa6n+sdO
Cv22CRZjlba+PPDG5q3WBSabD1HaCu0MuoZvi2No9zJr52xdMt2zboIkjqiMZNkqnbLgy+DRzYJd
M7F9trh2vHZJAlaRhy7c/Ji5ea8esYYojh+xvnhrhIzePnbys7egdVIzTPU+sUOPfke2jI0t8q3v
TIYXerWa9krWJpSjqjGsg41U4lvj2Vr74E1etk2VrH5Uv299NdaJG02lKHnPoTwbwtQ2OKQM86A9
qETvuxVlx8Z+CjTLUmvcqQMimRJ9C/Mf2a7DMr32jdh+aFKyX9h5xRLqdpDdFH5Qb/BdsLFxx8Lw
2X845BIW2sJCcvHNFwvrzyY2B+3ETsB4mGrfWc2k2NadL6Y12zMV+eQCTpWX6jdzm9krDofBZ+Ul
Xmjw9XZZRd7ak/m0s0lGkiLAdM+QtbdK67r6WCrh35V+L7aYXIpPM+fEjv2abJ9mVXT3BWqFT55J
vkeDB7GtTFd+8gPnAdV8szG71Nm3RkZvCYq28mBPYvgmBPtoT+S3aRqYX82ekEO2SlvlxpB+VVND
VUeM80ZbhvmzdCls2y1ZxjAhat55mb/gv+58SixqMPe2NJMnajPBk9G39aZjQGrLgBnDX1472yeq
BrQxuRBgUfkgyPmAk97+iX5DfHZ8Vzah1qcLb2/AyOvKzLOnZWSCL5+S5oXEO++qaVZOs7YUhQJs
XM6dW5/XBQptT0OUjiMk6kGL3NVUPk4d+gln3fRB+2GWve+T/dMEil5TJ4ND0wlBMDGmw6KZ5oFj
tbplMjC9wWJg4YKpJmy9eqBJmChjcW9kuv+RMkF8xEPPAGuRGP7HZhqDve0AgC+NIv1UT+b0ZVni
bt1ZiyQ9Z6jNkJtWtYIZNz0xv9nhtq7T50aT4qA0Y1jzCqLDv+3sQ0WK5yf/rYvIg1T3pVsFJ1ek
XWRLVMDA6POfSeKgcTfcPPISn0F7lST7lHW77dE3kX9x6fJ1s9Y5WINKMTlVAdu82CvDcsqWU1sR
QFbpHLS3HgnpJeQ1V5Bb5ZasW0pq1XqCicCY/2ItK20gMdHpbfUti1P90Mp+2tUycG/quTVucpn9
D3XntVy3cqbtW3H5HCo00EADVeM5ALASc1IgT1CkSCLnjKufZ21pbJF7W7LqP/nHocrbCuBaALq/
fiN2jdYZDw6x2LeJlZCmomJIBPbLNruv64iaJZmF9WHobDx/0A0T5AQDxTVcG8mc9PQQHttO0quL
tOMgA5GwBUpQj1arDZt1qtTVjOzPRbKVpccemaadCFNMy2eKoxR8EMt6HIflPdUgzl5DeBvEIGcr
lTwNMSOLoivYm9JRExj+DPcB/MU+j9RaB/04Q8eHM0xNOjUVOrBOX3ZAI9nnynVjfm6naYNJ2Snp
sIXaaVlmfiFJj4dizVM0LzzCYsuzmKBWK4BBJMLN3Gd8nj810ZFDjKNVO3FjneFJTkt37fDtXdY1
7S2Ntiy7SQ7xI4fu9ONgxlTcz0PyVVghSxNA+RSUMRQjIPdcnsvUoEVez9cxcJfQOreNMt2sZWIQ
ktuHt8s4YwuuGbu9CARy1y+13Mhl4QVD6xCwISV72pLsVx7B8lCsJcqpwcU4yPNwGgGLbibToQmN
BhjDl+Gy3DWu0Z91segqNmY4g2NXXLtjDH3g1Dkew3qOxU6t0k9WI1Gc2ICzIqeix8SgWK4DjDwv
qOQLkl6E1T4WRZZxRhXORdtPovEqyrPOOXLlu7Uv3C3iRnFCSs3ysHTSfVDG3PMm2UVCGnUT14I2
gmW+N1366jYaH+4yUeQHcXCiiCcxp4t2MjBimsdy+oz9wtkUUdFfOxFDiE4vyCaOLPcmxSJ5mKTJ
XkEPwrkkGuWU5Mz2fJq7+QSmrvjYWDNniwxXIRyvvTXEcccgpcijCkj4+hwTX58lFWt4A9FvrAsl
K1O0M5xc/xSx7cLnWwKbAaE8rtcL4HwPamF6cEFfnjPCMshdrFMoQFVGe2cRdM+AajdeqTGUDU4q
tkDx4mqMKWdkeCoDwfZ0grU43s98mCs3L2sGxZGqqWUIzdOU8yMqtpwjUjHn7onVspZBxkeHBQDs
SkP+Znhas9YPZZbp11EfihPyjsUh10V/HpqWcWlZafucl9WUnnX1MqJKsHu5783W/pQNRX8vhTCe
pjbttr0V4aF1+uVzmULhng7CTcS2WDqdaqy0Hs9Z3EFOpGRjThEkzNyP+9kgW2HXhZbgfvDTtluK
oJaXcekIlxuSEjVfw5uTu9Yxtjt3p7uicIugK2e33GtEbQLzFOPNGitH0KTO/hvLkURG23JO+2wQ
h1ZW2iYk9fsEFmq6N1WYb2sNC26vpzM4gdS2YY9SMSQH7is1CZDnrXDbDXRYFdi1Eb7OFk1AxEsk
L9XqACLLVKtA2UZnO1aZMPy5G4ftYo7yqzTHck8f93AuyzFitq4r86FKLWNTQrNeickuMWi1rXFR
AtTsdWVoZ/EwzhecCmpCuyRod9y6/SXSSVoznEVrPg2k6PCUL462bxPN3g0ims70aExzbxKl6a9J
lV1ieYuGTUL9Lo8V5SmUrM0QxDQPVVVNW1lPg1yftFBjBaVTn1n+cC6zhR0KO19bP6yBMMgSrG5R
XdC+txo1PQ6JxpG5caj87nX7I7IJGm4j4iNBtBboiIWf/jZ0ZXFjgcdeUBqlb7J1ta5NN03hHfLo
hAEwOYGSizfcvewjTmKgSWEZNwsFUjwAebHcsPh1B+ZQF3hSZM/r0FOQhM7CH+AesTmtubjRcBrd
ZFaVPEdlIU8bTAtfs+GIelvzat32Jfm2FRDl1pGL4wHphc+EVDxFqu03jT4y9xYDBB5jxKaPuxB0
vTCPL++w0/EUQ8HB77fJmG15qkEA06ILElEbW87InNvStFwY5croEzZc1/Fnp4fLD9Ppjszk+Yrg
WqzH9PvpXjvQaU4ClxEYDokeGi8Rqg3Y+12mpj6gnjO/aDU7OkuVk93MpJOCwtsyhTecx9Mx7sUt
xfd96MeFtPxGgN8nqZPcJUUxXeS6fZTe1uDxM8vHjW3MYDZltG7iOSucfasD4FIdU7NwkqX9ImxH
HUZRau1GW5ckPl3cLPQq1v8V03ndBWUG7BVMGfiLEAshNmRv9XsWu1jn2KYXRHiG2nhelDYBtt1k
Rzo2L0N9tGELPyItCS84Fxij38Ta51Drp60ZltoesG/am2Fsmt64NulJChzJxlG586eZxsfPMcKE
Q1WL9jwnuuJMtMq6cEqMZX5u9PkmsqNQ8+DYURSWWZdk9EIm2QOLqt3dGENYJMFkp+5ON9iMA6Jy
S/OpbKM2yPUKgrQkF7dfjQ5AjH7E0i/yetKDtq+enLQZpZdBN+wscw3v7Alp1GWvYc4Q45R0dya5
AO42ZnxLfcxfabkb68XizwjTsKNbrjG/KnD/gCKEckTWwKcLeseN2HHX5LPBKhxtGZX7rwJBzqXQ
bFCXiteTwAc1lQnnOi7+qScz75wAzdRrpTb6Jb5HD7OqoqKPGQsRdXOYUWue2rBk3GlhmVD8cjrX
Wiv2e9XZ1qYxbLfYr2EWZqcMq3M2+aRlqDA6HG9YrnkhL2wAS8YJmjMNYQRZ44C9SxGdN5YKyxuK
86qPYVPncaDa2C0DTB7Yb+IqbXPPJc7gmVlr0Jkw2qU9GANAAXxlBsQ8KmoYN2ahTH57OzEELbG9
aP7KTD/QBISLy0iL8ONULsmETse2pp2tz+V0EjVZVHkRaXLaQwU+s28NKG324fEZHY9U92UKO+DF
bq0x9hWJlbLjRUPv8z1JuYOCUF/pV3T0Dfm4VBpmRpWvO2Egc1/beJBBsrbG5QotBIqSxfri2XUk
N72U7elsZfajYXWQQqXm0DZorhRZhCiKrrMltO+6okJhEiNqMi0xB2oalpPCwWAs3aP2owI99B2W
MKZ9SWsrtw61PQdL0sHySBc73bHpbzPjtCwAtcNxq6cRFgUseOhsyumeG+Zs26E1T4qj16hBdv00
LT1+NhPI7CJUkwz3jLuzvink2NyDnvYv4LzlPR3N1q2lm63hpeiqTqF0kMVlHat2rVlr0A4RAzr6
cCu/yJN5fm3k7O4rQBmwcfIunhJ9ZdjvjCjetZ1BtybBUkEHSMem7ETuLuXBfnBJvGz80dVkkIb1
8IBlLbuMkXTd8ijHF/Q06vfGWDleZc7zuRFay6UwZ5t6gWlpAzqpOIs0i33raJ3ms3PYrzmlkluZ
Vg17b6XfrdU6bHn/Z9+0U+NMMt6+yP6ILClHLz7XzjLwUMFa89WCrqqodE4o9Rq/alkCGd3F1DGO
QASqz2CUw6qu9ohmmscRGc6p1qX9qXTiVzio8Gwh+UF40JzRF/w5MkbNQkmyT8coXQh6qqzH2rqS
2V4rSQ4wLJpGIE9bL56ohLUaUZ+CEbgnreFgBS3GieEldiqK4UYrik6xfqzPkxMvsJBUuYLvprcd
pV1nBRL0Z2vQinsJ1Ugwd1K3oz8ig/cEDM1pyyOyZYiml1HT3GteQPemqvPwshlk5w8MeNt5EWWQ
twvwNbncOQV/HB1pCa5bdeemdXpVa1X5OGk5COgaVvA/YV9d55xPpD/hLzO/Set/q4jurir4z38d
/8xXFPst6qL+v//rzT/tXqqLx+Kle/+b3vyZ7r//+OXopTrWvr35h03Zo9e5Hl7a5ealgz384+//
/jv/01/828sff8vdUr/84+9fqfvrj39bBI74Y5uccbRW/bO36E8FdLfJS9s+/u3spSpf/vTHvpXQ
aUKnhM5QritdeuYM8+ge+tZCB939wdTByVxbpwhcF0dLb4lJLv7H390PLv9ivnEMaQhHIUXuUCrx
K/YH1xDHOjsIE+WaLir3//38V99YYL66fyuVfytptpR0HWRKlm1KC+W44xyl9D9wxu3Sl1QZOoch
d8XjUkiCFrJ+6J8oM6x+YdZ/K83+41LCtehyByKViCGOP8oPl+qQxjZNMx9a3h9/clwgEKt3fiHI
/+uLKMNWLJAUS777PEZtgOwnMziUDQtoJNNGQ6vwi4v8xZdGC6AF+UjRl7LfO2LoxXTWppgOfLn9
s20xwlWGOV0Dh4e/Zb+wlKXzX6BDQxe2LsX7sFB8a1McTtUhpYcdACtCu+rXWdUFPzy135+Kv5VA
OxUAXfePv7//1r5dxrF5stgOHfPdt9bbk1urqD4kSKnuhrgNfV0vf894c/wstjQNnafaknyW95VH
qbsO8zLJvVVMHE0JCmD/6xDqBRk/1WFBJ/Rb6VDfLugahuEKFxzAfh9ua5Dv0g7K3IMXF35f0rSM
ntHZ/PyrO341/xJbfL+IdJVylYU82npnPFA9XexdYe7HRGbop5sQCTnCZomUJHBads7/l8vBPr99
ieCP1xHx8F4raB3WUwMynBn8Ml4HyfnEaa5/frl31sY/Pp4lYaGpyWQVsu13ro0V2G4ALtrny1Q+
VI2ePNUD/AJ9vgKtcutk4Qm2dK33EGPbESlKAHmeNg/tRz1yohVJkTW2XlTm6h7ulnQ7M5rZn2eI
pqukkQSYkAS43ndFU3Re3cXdfqgyfXyk/s3SrtvZMLh21zXiF7ft/SuM9IYVz2QQp3udt/idjYZi
41AmzbCPqa3cUSzfnheGI/cMtckv3Id/fkCwa1qs8TTiKhtK/O0dC9HK6oTH78sIl6dmRsofyBV5
ocrF8pGR1r8KXPmrT8ZlqCi1HWmZ75/6HEFyV0ftvkxUF6zTuOwY+Kd9rs/Z3c8fjj+vGnwylwxo
nnyFVundszinXWrjQNnbWA/9rqzQOJNZ4P/2RY7LODsg2wabwrsbNWQl8hwAPxMqnbBRDS/KVIjt
zy/yF9+ZJfi+DNuEO0do8/YeERauiUEV+7GvEKDNNVq0KJq8tLGa30qNOL5PfBAuYOlUzLIoHb/T
HzZBi45QU0PdmjptcpaKXttWVVlv8ik2f5Hp/Rd3xzKgQvk3Dzqr7tsrcfAxUPIW+8WAiowKMPdE
EWDy+1+c4QhUD6Bbjnhvqkwok9E7le0n+jA81Pj0h/WCfaQc5NXPr/SXH4f5xLB0Q0mOTm8/zlRE
SxMu+V5zk2VXTWYStLJQv3jY3tqjv90dJjLTplGe1/19ZqbNyUeafbqvlPsIbrKc12qozyd4rpsS
BcyzqOf6F4avv7wkza1MEYS/me8jhmI9suioT4maaIj2owF0q0+iIGtlKffLAuGOprP4Vesg8xZf
19tti4HUtEmhAz2zhPHutVJqANXGn93Zgi6Q0Z70r12VcBBGulNNQZhR4p72S29wuK/7e1Nv0ycX
yR6nd7PqWhwAun6BeHy6XKYM1C20q/bEnm1qzh0nLX2HJUj3joIB8v5kF27x5tDKEWcdgUNZ62J5
aGrLUUcuXF5YmWqHq3SsxmQrclCcGzspndzrG11XAYBjT+13aBToYK1sjB8txJr6DZI5DYkcD430
7cYIL41WpK+J5TaAswtf96YNtepOm7W63o5Gp+NwyKa9viKC9Exsv/S6D7radA1fBsx+MZ0QWkkZ
s+AkF21I+hk3ws3m5DDmnXNRiTS8RyuJ66wQ0JF4TUMOz1Ynd3PWL1/yQao+SPPMGflx0uhFKxF1
097AgbCwEpVto0iMWZCANJw5VV8JDwhmBODGe2UHUTE3zd4l32b0YKRcfCOx6rgh+DFI7WgWFvEm
HZcpyFZ6qn3q1jDWpcpODL9yrCnehGqVX7AsIVzKurF4xUqVXbQsZ7kfmnA6TYPLDjcKEg8A/azx
OdCKZxnhTvLyzh7v9UjU60ZIYz7v8l7i2HDL5VkjHFt4Iaom0l7iArBNT/PmFH0SuvBlghbwwqbs
7X20DFUZVG6fHkETK0YRmJcoF6U93APk9U8hL1iHbi9CsNKs7XiXLorgmDqcYq+f5gIdZTNrS0KH
xgSU6TWJ5ZyNKk0I/e6K7HqFsjbP15j0QTsWotqhZEBtuxIGhZq8ubO1Kg9hQdjz6oZGpC1hDwiN
67EbdqhHFcgj79oNBN+xSaMvzZPeybJPi+WsD3lUiHNnnqPPjP5ztpFamnUbxnxrAaUti7uIcDfT
g3VXX4oFV0kAkton/rD0HGdq1WLwMlKX9HIkp90TeZ9qpOEar0ZgpnbyOOB6eu6OAnzfDaNlJbmm
qovTtMh4xUnK6UJPTHP+GtUY7/wuzw0VpH0RP64Q1OIw1laYfKw1eA9vtQD3vanvs6M3ok1vrakw
e1/jQNlzejMVymmWlM6L9KnUCS2NtAWmQ18hKY0cfScmpUMdlQ2ZVaGY58CVrbZjHoq0YBhj7ZOp
UL8F4VFwj1i1yQ0vagkq3jpaWD/Eo4tSONGHZRezpnUbuGjsmA5icnG9hgJ4NIZu/4ypq6r29ly1
UKZL7nzKG9ICvTJGtLF15TrEG3vM3E/LoM91YDaJgZAq0mWNRiLK+iA28+JjrfhTXu/CkXqpGmgU
b+K4+JrNS3KbJ6uFOGHiRb+olSoIaLML+UpJXgnc0ZXICNaipvjQxFRQBSSA8tntwkHLjTeLpQRE
LvxqdwBm/hKnyQiVTMjrtrY74wih5mnhoaYeeywixvw1dcx+RlWLcNtvF2PB7kamK4EIsZVPnxAi
ScsN6mKsLNPPxx5cCXmaGrwlgvjzWiFEDMnafQ88/i3M5Tz52lZd9dq/R1TewC6X9Ut527cvL/35
Y/3+d/5/iL0cm1P/PfSyyf92+5iPj89V+yPycvxD34EXR32wXWEA+h3hDXBj9sDvwIurfxAG079l
M1BaLgPsP4EXIT9IaTrS5Q9ZjOzHgfM78gJcw2Zp8v7rDosgceDvgJafAS+m8W7otCzJyZRhkL8T
H5XjvBsFFUkXi7na1jYdw7vB1u3bbNaqR6O1Vxx9GayjHlo9dpC6CPGRhqnpj6QenrWiaK/6qKKJ
NHF4N3upawl4rTbydklrua9Et5zSPFDEQWlH82XkKJ55vbO6g3D7OSgTUX4UVp48hLAhN52NlQZv
RyWurRaLTOuK7JTaN7TuDMGHxDJmm6DPuPYVRRFBUSn11PYkcGJ4WwlNWUY73aC1azdDQqShn0S6
+TlONFPhu8mWL2UKDRxksa2fE9dzVOCshXadAj1dw2dZz+TZH/1da2zU3tA1ob4dWjIp0W2A5XiD
7KJ0I9acI0BuWIWPoYeal5wN1d2ns0A/2jCfAZrOaXPfVmo9mw2RYWM05ENCP7zj91oO4UH7d5Vi
WrDcz3iK5GPGyn4S5oUe5E45obdfQpcTqInJoQDU5uCDa8+pn7UyP7ZLmwtyz4yXPA+4AUdaMOov
c8Ns+eizeU5HRZxujpz4yVSPu3LqT5Bg2sFqO6+MeP1dZBQmtprONYNxRfbrNbORpr6unOJc5FqK
Y7a4kiw6z9iE0AGmEIuIwnDR9r4quqjwLS3XP0ZDbIcBOt/qscKtbAbGCJVPj179BWfNlzlDYZtK
WLWcjcX7Y/zquwnEPTXuC9mbUUBnouallnYRWho8+TiO0WtoOhYtmgvyw1R8zER70emYc9pwMIOe
hqCHsY0fMjwSfm9piDPSPupOldbESN5yzKsNzQ9Dg0bOTGqUh125nYqyP0967Xyxh4sIp7+nskLa
fuHMnErR7ewBJtmWCi1frsNGt88zEiMRfMCrrarIvlp9hAB0Qcy1s+oeOUIWO87ndUUTHQsU/XO9
3K1xFW2NPK5RF/QEOxelA19jGjUYeN/NG3YtM/bS2KLiMk9vR5VkuxnBXFTwf4Pd5ZvCLF/tiaAF
bTbGTdRp2oslOtRb3fDYlgw8+tB/mYwFS4lp+UikE8o3x+GMoGKPVICUrOjhwZ6L2kOEVAalMJ8a
uy18GdtG5BmutlWd2gwY95QXWjDy1Ocsh8jMIk/Edbct3Q49UKj2c+9ed5gYt4rR9g4X2ksneNid
ysBiU7VXtYX9HhK08aqO51RDV79uWlWtN2s/CGhLTUk2MEz+mxpxzX7KouQBeYj+haylFQ/VNKHD
WWoCMmw2Wpkb1yi+jx73tAoc1PQbY9any16ie6VP9BO1BDAg5J8/GSCgFgrwzvwCboFFF3s38kRs
FLXflCkKFLzzrl+gMkE0x9tEIDHP6mIGi1WhwtUIj+lJ6PVFY41+ay8jfeeacRK1TozhlDautB6k
byK8vFEh/gLVVGJzJDX8RGtdjwSdbluFR4/ElNkastKycz8ZsxJnpPYsLEA6VuUZ+4oZmHkT3km3
0KxgbRInutDpJt3KxVoxficmbPiibmS9lqQ7qLC/Ij6yOXGxOn1eIjO8xck2yavKHREBUJvnx1ry
lMl19Cd9yU7caZqv8jy1bys+UxqYk5xRRMYIACKxiD1Syeo2qjEv9KNa9zLr3R3yrC7IpMpOHKwH
DHSIimzlJj4jmHYzjf1RxDQX69YVMsUtuQoI3qV0d+OazpfjNIszEofrxW/y2UXuSjyIBd++wHFb
BA9jAzoBN5mvlpSkctaManzBss4bNnf1I4ZL9gx3LsPXwXXq7CqMnOYznCHccWrXNipz1YmzXPWc
WH7Yi/8CUBbvzpdsbqY44hzA1jrAr8u2/CPOYbcKECqU1paAPdJkmvgEtdp5NFWPCBfwoOMLItX+
Kidxz6uNZJfmujxY6cy5rMGRke2iMeQULH5VQfLuuP3t57IczviAmhaYxdufS2p0ffXA4VviH3p/
rstP+NpMJDBi8CJlb8x+/EaK/VuGRfx5nzcZNsBHiCSA43mPYBllmeDzGq3tGLsX5N2aXmMPGzSB
J0VinNik5SIyyPaoXaNNgtzbI56h3GbtXVk1n7OySQLbWbtfwCnvgd0/vgglQCaBvZhm/ogQ/AGI
MvE+6vGScINIZUEkHH4+jrFrNdlenTQmOpD1TnCwJ3DsKxKoAV0AtEMUa3dZYl8I08bnXKUDh1eO
q27lBtIqEPH1zh1z++Sv3fCKlGj1MJOeHN+jP56v35p6/wOm8T8bjP9P8ZG8aP9+KL6tisc8IZDp
G7l5eP7H34GB/3citsQH7rMFd2gBB+ruMWLo20As9Q+u40LJKBAomDqD1/U7ESkEvwQw5XKKc/lf
R9ru+zysiQ+g57zcrrAVIBJwze9MxG8RPt4LwfMIYGkeeUhH2u+XjMqdOgcqDLXv0j4lk9mR5nH0
4P3wjfzF0vR2Zfp+GdME9nd5JaX+7jJGknZhiBGFcIq0YwvpIgyT6EpHPao5yy7q9ufXM/7InvoX
1gaaAPmrJDoQw0D/yOHi7ZoTZv06ha12DAckSqoHEiJ/m1Cykgw3Ly4W7WiP1ZsB7cdU1AwdTlez
LyU2JoXMl71bAQ2WqLmvW1kWzgn7u3S3UuK9d3aZg7DeQAZUZig8xl5D0OMnSTr1VpCgNeqpGpNY
PMgyUEuI/I/0m3ZyMdZrA+2JJPqnx0JM+CO2ntYcFNZ3VTNdT6ctPdsT2qR6HBHH84gc6+d0qVxk
CrpJXVyQu9Wi6C53XHRV921ZIOEJmkSXsByzjtMrxJ+bu5SUKPaKli5jN3EKdz+XecSMSyGMGX5h
yOvXT6oROQqUuRNHOwq2BAdrdo8SdKfLhkgOrx9XRRJSmdEVjescudCsB5bSZqf29RAmAqlapTKk
tRbxF5bn6JPKDvkKBhrorWmXBrK3HF2VZySFNZPX4Sau4TuaNEH0ZNwiCEL2ZDi4B9CVtkirEz0+
KYYRBWee8cFR7iZVW5wWKHI/46pp7EOUulmySetVVDVePSWihy7Si+7A0XIxUowWhVG9Lmnf3h21
P8ZBAwvC7jKvBm1mjRkLr7TE5JKkUTjGnYS6mWHL2BM2R2SPw0CU2q1v6xqx4nznSM5nIZ12W4e1
G3+diGoyX8oKYCwB+VlRVRtpaRanfWMKLVhhh0zpmaUcHQYZYaAwSvAYbqVRLBnKeHaYSfPtvJrd
s0ROCpO0ysLwdJbzWNzUq6ZVJ7ZCEJh5hY7VCsFs1Gj5GRX2w3B7hHht5EFD2dws6cIFM05a+gWx
YpN5WpFBkfmdlWhz4ueZgZZmXTXqIgqnM+3VW4xplCbQl55gEevc0D618QiT9hPF9SAoXSjr6lRL
EarRXWyR63QQS6aj8xzzopKbeRrsut3IiC6HwctTg/xQD0cOORYI77r13h1NgyijFrmiflNQ/Jgh
NDqGk6BkSt0rs2oM96KN+vpoO3eyAheLmQwXeEVMcSfbzi4gdHHjHbRwhUaxdcez7NqlRqKnR7wc
wcsqXDr0z18ko1Mk5yT94gpazcWqDw2mZQzPYySnIfPzVncbzkkTYdjQcWu9HAAWTfsktXuiV0HE
YscbVG2LYOqQxRGwFK3rEUBtmikVu6TtEoX3srbbe9DtbrqmDg87M6mlbTnegvFKVKm61rAje6Sn
Zw+VlRb9KVYL3FhpBDPJ6kNHKpEmg6kj40OvmRrZ4CODK5qVSXTGSM9uPYA2jreykMSo3S4ulk33
gjULEM9HEh/lw3VI5O08nDa1WlrnCRVYb600YsVhezfUWIyX26aaZe2RGmPOlNy3NRBsOipO8Y29
6nENQtzSYqxSO51At9ORyLEptmPbH0U9mThnWUpJSULjBwmx8PARMwTfrbAsZjo+kEIz62i7tk3Y
7lTXK/3SVZzFMNuUHH/MrnfCoHWsUONUFeVNQMJuwiCj6UN9sFk4xEeNtBjCn/IEA8sAOiJPMooR
Tks8WxnjOrfDUxpw/xE0IH0iWMK112J/XesS23BFMBEpw2bbzbiqVgSybXofaSOWktNxcccov3ZL
h/bH82gswljDJppDvf1ixH67XbKrOLSpsIkr3T3OcOY74QHxWUNvOhhAzcGKcDQVA9qd3EZY+vP9
6y+vA7UHTa4bhvU+VJN9X+9ziSmgympCkFATj7dpxcHs55d5uy1/3yTJ0AJ0Y7dU78vwAPmdBqUo
58VGc+3DSixSozdEBVvtmUShb2x/fr3jpvtmU4agEgYDsGtaR2L5/aZcKWLJbFr9zHUeiPVCPcN5
qiLHWeGTigqAMIKB9EeMRr+qNnh7IDjeOZ2ZgFUE+QG37n1wdaWDmIUZz1hvhfkmnXDb9piFtrqO
D+nnn/LPN48PCfhpSMdhg35P87FZW8WIQ8ET5DBeLrGRnYVoZH/xKP75uzx+EI5UkvOegnx6O+AM
wPudMkHJji1UVKvPUC96WFhfpCRhi2B1djn6fPcjR4Nvt/G3DgL/2ZT/fw3+Rin4w73+k/TwjgiD
N3P+8bd/Q77FB+Ui2GEsd+HmOX9TzvId+Ab3RuwCgs2/6NnlCIyg51+TPrM3rzM0Pg8ML8c/J337
A54ck6M8Sgy0Mjy0vzPoo6p48/Ipg3GY50XA43MM4e87tsf8cPisycois+kVPE7aYKW5dqbSUi7n
w4Bo32+JPVofa1UtF2ZZuOIsxhid+wQaxBeaIYpXbJa47s3cDq9gTcNP+CD1B5yU9Uf0b7G+MYzB
JMrTakheiyMinjY2mM5jpRkNOZ2TZrMbYO8iEU40LKCZNQ6XNZMzKhY37rHCOqqkjwfA+MrM5TFw
rml1Un21xryneEIuX8sQv/1nMeAAQyQNBLuLyGuaz20nSw6EPIAqs2/bzcdS1BiYfS0S9kcTJTbh
CoLkVblkUxOMeZXNm1H10MV+CbpnbtTRZEA2SqzRnLSIsd6lnBrElhQqkd50sm6l30dUQIeDJm1s
PVFxTkJTdkxOqHom2HFxbG+Ou/ZJS2fShRy7ZyaIsqPnB9BmN3UqSa5G4KYYR04o2nwDJ2ACQU1J
Oy6X7dARTWCZRHuQs7LSBglThwtwaTILqTQpn6EvGzXc5eKYlYYX3HG3K2qTjsG6KsbuuQpJWPBx
M+D56GbrIinnZLAoaEk4BzCSRjRzchh8dmGiR18nT/CVZSI6HfHFceRrSY5q+hoBdiOzqdrWRNYX
HulPzzIMCTWwiarKNi7JBImHgV04W6RUAykSeMhuncxwLfpU3XEJICuIZR0TTA++ZsAvHNzQWvUd
WFlz1q8FBHNEGgL8gc7c6pPJH70OYRfBQmQ9TwF13iGjN3FqM+lbLnxq1azNczc6XbybQHtSUOY0
wUuux/B8q97Be3dNRzpWjg91rJZE85y0OBpHSTKE4a+b8EvH/pn44PzyUeE4o42urHe8kaC3ZThk
t81Y8cG6TMLPT2ZOLkFmqfzCtTT9s+HAAp5m+dhBYXKwmj1kp9hrzGHK/Al7VYeRg9Ozb7ZR8Ww3
djcGxmosa8B4PddMs+0xiwvo74Iav+RlTciVRLmVVNeciUj5q7q1esqdaCLTLnazTYjkowjMwuoh
Wpu8/DJbRv+EU0GufhUX6sUYk6Q7LKubPkVuGl+RY1EkCI1ImCH3iFwSAHJNM7yxtmm4UiPjJXCv
TIj7oEzlMIJSM93rIO2nU4IwwhNWu2o+B0Pt0igtOQTunE5LgNFjOhB1NG7ziKJHTiNxDDekEZYH
XEXfSG32uub1Q3eUDfR2/kBaaXav9T32HgSHpPKZjGlP+WIW0iMpCqGGXinGS1UQFQ7MjtOLrL/S
9p0E2D5YBcZwr9cM+3/YO5PduLVsTb9KIsdFg30zJYPRqLF62fKEkGWbfbdJbjavU6Ma1FPki9VH
+VQeKewrlVGTQiGBi4MLnDxiBIPce+21/v/7b2iVIZuwl6b/KhbXa0M67fgqF4/yk+SAxAr4Do61
Azwk9GD2VMIjo4hOrz/1vXLXt9FqZ5Jp9L2gSQhfhvJRnIHB5NzNwAD3GgV1ebXQiMNCCt9zk2EG
/j4lZn6XFACB/YbnXjDMKcvreO7whDJQs3dLpiMekagLHwcMOF94YnCDqFT80HpZUahQY2CSTgfE
hrZqbN/pXgZlY6ndyQ7gCtg6QpZKOTVlZH0fnxsuIGTtsxobZcuIoIA/lHZJFYdNUYlu7yyoXeHa
SDmwoApzV3lJITdWlFs76GGeAo0UyfrPwvA/O/w/9bUV/EYz71//vf4HTc5//Y9/PFbf/nEp/vU/
q6e0+f561+dP/Nz1nQ+0zGg1UU+iReZwzfb9c9e3+Tc0ZNny6Z3opre2vP73ns+InE497UADOew6
K//3nq+oHyhTn8txz0X6a9K6+iOrwXPe/d8lt2NQgJo0nF2KktXVcJzBWaArmqt2gKNqBvSSmoNa
Ld0UYKDeq0UqzvNIV9Jg7DMAw04xRAendC3aF/C4TpClSKK9cqe8U6e4vbQiJwZRgpDmy9xKZYOu
sr417RjB2ot7/pt24TPy/tWnxo9MFWVTEfFPbVURvKxVciwRhXAepNXkuh9JTbsERoDyqs+77IpJ
Hm0scE1XdJGg9ZZrSGTh2u0Pl2bguUH08Qmm5eleQUB3UYAu7bGpKsrZaJvM3VDZf075V7Biyqa6
5YFRzbCkOgp7uMdnGneSLSQtlCcRWeN3NZXN9QgbeGsNhvya4Vs+V4BVhvRv2Sj6aIju9bkICznk
bI6LUCCSL1i/fKTY3Q80BW7QpLV1ZhQKdtmmU94TFr4er7j4j521U8wpkQRh1z4Op+x1zy2c9Wah
hDNU72NCNglyP9o1ugMpW9NwpT3/Pv9ZHv7J4E7FVuCuryBPHrxm7vZ/vVwEGMSa7yghq38cuoIV
4+U68du/9ZdOhr7+h3UFWMt+TEXW2nj/67iw/iuOjywOnCbMtTv/98qhfmDdoPnA0MDF1mH8fVpY
HU8uJwhWE9dwSVt2/+S0wBTg1Wnhl49+nDzrxV0K5dnMDkN5Cnnfd7TvJcAIs5p9BTupNn/MnY0O
wqNlQnrXxlu1Cj2xyazQTQIrOikAEda+6QS9GdYM2p5yKMbqwbOv2/bSjj4uhKBH7HdscJ/cAav1
txT6ewVNPO2fWvNKM8+i+FZGhyQGfhjAiNSsxzSh2PyoDDDXTlr9tLMva/fMzC5ld5rzz1MlOl3S
i26i3VcFRXTKow/jDzN37Tuo/5b+o2PuYoYCav7VqfZRdD1691aKMf97LogkMMHiQRH0hF9JAMKw
Ly5NUJ3aVgIBrEO7uqWFnWO1bzdKttdBwoyPOpA1AS5bi7ogG67L+SYxbhf1oOSftOWLzA8OeMpu
X/YcLU7jcSf4O+PWblAl7CzvzCaEaSnuPWuj0yqdaPhcTPPOTremdZF4Z9oYZsVp1+yn5MQYz2d5
OQOjjkClnCzyQam3BUcAVW6N7BJgTmTsHbkXy+eNFe+V6WT9v3q7mJ+S6WrIbzFZ+woRBuV5ZX0U
5k3b3UQF4Lc9C1OWh4kbwlip4Ccvmz4jv+lEKHuHKNH8vNG2erNrk59y+T9aR34/UVz/xL+tjP9v
2BLXA/MbKwGC3KF79frzv//5thvmB7Rm+AE4zzPLe97Ofr7shv6BkdhqAGMhwK6yRkr/VSUY1lom
YHjj7O+QyLVG+/01A1z/Hlujyn/luOuI0PyTd31tMbzoyjFExOmB7h79HcMy5o3rv3/RGKg9E6FJ
lC5BKRchgHiMrYbcOK+HQLrFcCMsKa+ADmpnXmNGX8ekhIlfm5r4OmU2ymQHx/LeKc3mDu/z2CL9
cjn307b/3EWwNf120Ei1aDO6vYFDhmq1hQGEHvXF7f5NzfC6H7Z+C+w3jFe5X1Q7dPpefwvROCNw
U0ULLG1mipUKLFEd3NJsMUFTOqu0HMh0Njz8+WWBzttUWqqBJe3o5nkT3EYDH2cwQ6nBH85rvPi6
Wl4s03LCEO98FMQ4vH3N173Mn1/15TXZO17+YJy/aMajzw1mdTpoUYMWfGSc1rb6Oz6JdQR99Gg4
691kNu3S+reOu6aqAGCrNJkepBStMihRRskNCI6k9bNKKrf97JmnZTI7gLaHlp6HApF6WgA9hRMS
31NmWaRvWOqI5i1HuggN1PBq8OZDftAASzyqFrohGDPkfQLDRZzSULkVfoNmv3inLas9B+C9qCrX
R0RDW0rbft1yaa6/vm/aUJk6MbbQsLqOWEQTKdBecWL5VM7ElXuIa6bQtBImblE1OFPolIZgksus
5rO3NCjtRvz7p9i7tPMoqpZxK7SBEBUGaBJ8/sxbkzPhwf3qoNneYE2oCcjhcDlywl6/pr5+Y5Op
3KHPGwJ+lgFFpe829SR9TBPWflzvmRePCwJHbqRZMRvzi+fb2613Ol3veQuFqPXBcvBTjMrYhqbq
RtoG2yLtc6MxoEUQK2l+nzMaXcHC8lGf4BCuJbLygUw8d8A0pi3L9MOEpjkGCRfRwgQDJT2T3jN+
5E26KEzFNYzCMHcZpUg9MluO+0C9NmCmTCBDiZj440DVGE93gtgUo81o8dHtIqEeqoCuhSgPEn7b
GZngajeNs5vZG05auFohejtdntA9igI8w5MVVoxBkOSjVv8EWb6mftVxnmy9eLguxLBc07+wbpOs
TubzRHPa7lKNvVFDFleU12XR13DTAO1traUbl2/WUpZLOJLJ4vqNAz78I+gVxijWqKRt6Mpuvq7d
eomDxJ6ZRqddHxFKWOSG5RcmUKRg7rE5+W7PpDsYBqHJjYuc8jBYZWVCpk0hB+QQbbddOs36tqt6
HfqlPc6c3OlABQbGOnpDijXegisWJ7oKGmbHf8UTQntLB9TZl8AFZ7T0N7atxFMASEj/gV3CAzlo
SuM77H6Iqi1NVhCuuRweTcsd7xutHs1gQOwLc5PhNcahtXE1oa3KApzv3maSshWnJb8aDAd4PHMY
Jc0Y7XJcpIHlCrsN6qFuP3frGi3TdmoD9PsNtBjW8PF5Oa/Wlb3u4A7xaLLew9bSzrp1D3AMq7/5
b+UMVbtvabssnuKFiKvscIrVVPMJKKa2AkeruBu4L+gQDTv3btOsXMx3lsAjgRdroE2hzv5nYzQy
eavXQ9GLTWvEwz8mTsyH0J0Lpu/f3GyWG3pMkL+G9AwzLBuTrv9ohmgTeQgCF2GfkSbhBVEsr+dl
3tNaC99el9cO+qv1hc+0qtxckx47e+rRdPDvGwNWmm+sP3953Lq0dp/vifV8fwCzo0Bo19s2rzfw
+TP8UUn1/+ts5s0C7PaxWh6rIx3Wmhr3swZDbWXizKXWWe2zzGBY/H/WYLr3wWB7w+evY0elY8Mm
+FcNRjsGNwLZCh6FhUN8Fclm/67CFFRajq3R26F0Y1DDH/mTMuyXqSEVHgd53BNMZwBMHD08tMz1
GNF85keYhumLkgm8hTY9vZd5vW5yfz+k68zX0ag5qShVEyrAccHStm7Z0kEkREhqw1NmjMOTuSz1
p2SIBzidbAhvvxS/fi8HZsbKhmCYTSF7VJflukBKBZfOh7tXbEB8uRsoRMUfGb5/fivqPyzfqy2W
Qvv1cpB0hkcyG9OBdFb0K6trEXh6eppc5O4CvN9dfYhvf6/XRRhXpGxn2OeuDwx2kmNJW66b0F8F
fqfMhHsDSSadsE9lxC6nWTzt/+8udnQTW3VextkAxtZqZM/viOUx7vLYAHfQ0ph7p5L+5Rd75jeg
cLBUtIc8K0f3sqdDNliSYV/T4hlpnGoTj5Z45yq/uX9MW+EbYBU1KDLXf/9iAddKCIUI+XM2mZlU
xdQg1jNH19bREv3TR5AvxNgf57eDO59Z1dGl0sIYcHJCJO8b7UAOkhXwUo+7t3+j3902qCEQguj4
8qgfvcBFOVjEBM65LzAD7PKBYRopFdk7fI11wvz6/eXL0OjTsUuvfWfn6NfRFYYnqkrWTx4nbrNB
D2MXLjexSfpdyVC1B87fy+68kVb7GAuQlGdIm1s41O0q1iqXUohbfeKVD9D0r5gmMpRdP5VVcT5X
mkuOET1NjVEa4E06Er1t7WyboOWAFUlQ98vSTfa4UT0PiwFxJ4ElM+/RLhyQLwsV60ISS9lde5na
toc0XRYXsm3tPMSMp4d3yoD1y75azLgZq1KW33ZttttHVQALAZkvikmaxpzDA7YQjK2JY8UVwJ/8
2pb0RAqsGttuUi1iS5TU+yPD//MqgBjIoEtHL399tl4/Wn0nbVcbLSiJqgKPeBSTrxrI+95+tH7z
rhic85GVcMJlhn+0uiFLUyTlUO4PLVRxokWsU0ZvcqOSKvX09qV+2R5YzTAPaA5fi4bEcdRtZls9
pWdSQPsV1TcyZ5jVVqD4Gt8WRnpTWZFu/RFv5/keckRhczao5LAGHt1DpZnSOnW5JLAiviIyyC1K
1PmdHeL49cQyYyIcQ/5AI8b7BTOQGpVIDS1aX09Fy0E0prgghDNK952N4dcLufxElNzsRbRoj7Vb
Irc7lAT4WNEiJCfaYmkIcbvp5u3f6XdX+Vkv0Ajm0Vt/xxfLJ3gYTLkKPl3Xm+DJDw3eGJch9x9f
RUeywg/DVQyewNdXIfkJlYCOSgvHL6TJ2iY2DnTh5dtXWX/gl28x/S9j3Wk4lNMm42T++iqZRw5j
nEKY9rqluUpx+m2UQYf8UH4jyc+fqkQP374ifJHja7IlrL0iJANrQ47a7dX9qyY7xqferepvWJ9B
p1aoT5KyAlbtwlmuDu7g2Z9MVNi0dKJ2De9jm6+QJujtDovzAHFSxa+8T9i5hpCkhs7dtHbs4vMT
RCOEqWmMbtiNWY/Eeyjnr52njTSyySsqg7wW+Y+lHQtzI+1e6Bu3Rs+4xRSKG8czegxqNjG4xYmF
ZA2jdoNgE8LlAj13ynTG9MUCirNaHLMPZsMYbyxvMr/EHT8Q6QGJTn8gjtBDTJ4xQnAkXtGve4FF
BFlxJCCftN33GeEnrZBRt+cgGsda+HPjkAnkraBN4KVjrgZTpDG8bqIi+Vy4KElBM6CVDyBqN/Wm
aDUxwMBPygm/n4YSEnkx4U6eMLT8ZBliJNZFxRb2pZgI1wlq6aJRK1G9cuhckmQ7pJFQz93FdL6a
DUKfO09FGIrRcTRj4mvryiGfQ2gVYvlNXNnDcqJ66E5WW33tfNIT9Kt8wok1l/DXtAnw+VvNLgFu
D8GymMbbhY0IX2BpjwQMQnGISGiEmtJt9MF1lU3UCJXIOE9Ozj7ujKQKvKYyngwegmKjuNL+2idl
Mt4rdRk9OrVcesQJvNq+YbnztVfYyrcpxwnmD2XZ3koifZWvDbiFW+jUehoAgHfLfW1r403sWjI+
wIyuGaEQt4qNUPFa5a51yZXzXSXVPvd2l3wB+0Aeb+PpzUMbV0h1ULs4XUzMCbp6FOR5k+D/w+bl
K3pJK6DVptjdElNXJAlTiaE1ThAjyWxrDor8AgBVbb7gAWUGo0iTkLyMnC2LHLfGAP9vF2gU204a
ypaQWZ0Qk26JGO9kY6bvzKRFCOyhgf+i4G0eiOjMFsCaScxz7uWGcV2oiIuCKrPb/puZKvp8CrzD
UA6u1WLrb9UiXvEI6FjJ98uXS+67ln1iGq6pT6KIiv5uFnXX7Qc8CFmgI8HQkPySKIQgJEK3I5vs
poRLYRxA1HNjK69o5YFOHTRuWNKxuqWtyCymnXPsKlmXNs4Pu1Rh7vidYWZPnVNMCiHUsCQxH9RG
eoKMpM/O2mFgiI1XVDZfO4WmcOxXdJha0JF2suzpc0TNt1bFII0enObtZh5o5QIx0FJiBzxYqmFU
lZi/R3uGSylJmyW5TANz7gPgQXUJSdjsNu1ctneaHtN8toqmrE5RrRC00ngLrWjLSE3XFzKm/K3N
Ji3PaXDo3XmSpnnJHM10MEvvOqMcbWvTcZ6lm1OntHqIlJTFBJ0aWRl+ShoxWCTxXuKG5KTXBXG/
1F9mGeuHMnOm4ZIlJ+m2uiTUdoYCgaG1RR0VWQJ2qTH0/XeRDpxhgKJYmVU7JAZ4sZvvEwEJO7/P
3FyLg2mc0gspibLyyT83Fwj7jgaqyQuXJW/Hke6gQJ5/utglOvGpWIrHiNvq+g4TkylsGt279WId
JX+cDpPjQ1Rt7ydX0pAbyykGrVHjVN3WYyHJHDdt+m9ilcIHJicEON6Kgb+Yzg1FqpcIB708uAtA
rzknhb3SexZRtkVhD99om85FYMh26ICKp8iMqy410J4RnBedmzF1aghcf7aCBgUiOI2Fk/Cavaya
+8mGHReqsss+Qopiy7aMEZ4+nmt8BanbOVXQ1m5TBvpoeJeFGRM80PYanz6jasFO2WXlTT/RpLtW
7ZgTDDq4dtrZxOR0/qCbPet0g1YosJtGvcJUvkQnTTXCDuZRiy/JPi4v0oyXgGo6Sm/4G/bkjwPZ
MZtcpB00b6y2HCjmjowXWIIklY+ZCwJ+6cD2bhE8ujfcKb30DWUsPxNv5NBare3ie9/iEScGWLc4
pC4RNlgWnSo9IZM3+qq4DmbehkOE4RuYX5SgkUrzVdEHB/NPluS3Bsg5mLCpbNVDr4EXwVKtSNI8
o4owRzgekoOIG60vC2luW4dV5b53epUo3Uzot9NUcXyknY9ETLQxp4iuBA0XLvNiPzZsnTR9VZ1I
zETR6y9l3YNSXQytPXhtWhMC3XEIwhYwsFo7mrbcK6ubbqv3STIGKWF5p7wckPcztWpIV0BlCTdG
HdRwISrcChIVhK9fN64B/U6UHV8S/P3dkHWwfMpqFOQaTbWZfCdRVIo7PqZVH0QpnYIHSMmszwtR
ls1pX6rOcEqbuGyCku5zEQ7QaSp4sDgwvpj8Z8NG61qnOWidNhIBK4iO2Xj2AB4cXDhitaxV9fhm
mJguhEYZM512hE4INlr0XD3vcgVsXCptw4UqpEjQNi3c5BMXoL8TqE075CFZxMqw82imqNslSaPl
MAO+kWdVjjPi1GXhScNJJyw2rBGuWV/AcOamCs/BysdDCdnI2KKDm9P7AWtXhNhT55/whS0yPMup
r/LAyCuhkpbitChdUcd17pVF1JD4GpFEIn6MWTT0u8rIyReN2R0YVbMwpziwoZL76IB1MgpYW7Q9
ravkTuQxoU+kl40zvlQ3qsOCDBqT/DAP3SdinpQldUzm3l/mfoDMYNpEVSqpsLqTDBFc5TsIW5hO
0O3G0FbZFRsqtZNxm6rGwAh+qlARVwXH/n1lEuPD1iwXA0u8NeiHbFRd7q6Sj3LTJuO4c2uDNTRt
OQ2GlZ2zh3E+xnhQAP6WJxZZuZWfThRlcwKvmVyeNVaqpf33UaRWlIWSskUw2WLf2g15naXA2R1M
ZiyzLurFJL5zNKJzmSU4VXSKi0SQXx+1CJUUFTHyhp3Ow5kCoCBo6REhM9WAIW6AM2Z3iaqNuIqM
Dnd5j+ktDXHYr/cXBvs9kwzeEbcocGlkVqEsW/YGTIdFqlg7U/TtmRErEf3CZJZoScfJYGoLOON+
6KRy0dHusze6J+wfLj+a6lstUI+wh86phjLSozTyIVj10w8NCNxDpKi2vJ2SaVJ2akT9GSiJSzyb
jC0hwpHS75ORR9YTIfVNdZY3A6v8olYuyxq+oxmFQjVAPKiUfFcTrD1gNEurjqQtDU+lVSTWuAqg
0OrC8yc2zEsQ63ZTqn7OiDr2AoetlPpzEnq5JXHdaf0oqg2MUczhDrG5gn06oZWASITDoR76EIrz
Ti6WBeMDUY9PBClvulUn1m1hZ/VX04nGbNfGOIl2ghVVDep86U3ftRTbCeksTO6VU9HS2dqx7JyP
VkXk+6TlUxESc5ljAC309gS0bYKAjhSoW7uvIZIkS149yt6puD89CRfrRiwURlYMRfg+Jn06IfCH
+ZwJiAChEWN8G1qB8rVKSQCHQlFqhHANdfNZjKt5kngH8pPSNT8OkpUApcRUjNGgpiZsRRz/cyes
HLe7Ggwe8o0uB7iqbgWTY1N0pE77aM9qQnXszrxvQJ9hbbSRjUjONu7W6hpQUb0pJ04vdTpfvX2U
Mo47Bhyk0DVwOLRXFSQ2/9cnKUZP46iR/+IrPUXPCcCXFPBNH0XzWR2LyN6mSa94u7mJzGXjpCPJ
Y0O+zJeLRpQx0WuizrcziOh5k0B9QdI7lYBoTJssystCtbTq2pSddBnWxRY4rFjJ9APBGvpDXyuV
DJeJ1fCKo3a8Ah6qFNFxbdsPOAcTBzO9YxysvrIdxp5NfG/qhPpkixF5F3ORauoOEX9s75QIg51P
I4kI0FKMg3x4+x79eoss3bWRlMGOZqB+DD5NCL+J4gqOn1tpGOHsJdpHHlZA3yK16q4w5+H27Qse
N4xoEequi7kbLruN6OSoOyDnzFGZRROiXajF06KIcsOhgzq5XnrtnR7Bb65l0jNiQIITiSHJUXNq
5XG1lNc1E/7e2C5QLyDWtePOQzK7eftr/Xpox8KLiNPCQkOnVT/qFHlVlHYWIZE+CQafvTSfzwnE
EO/cu18vYiPYfR4TrUMfZ/33LzorWD9IEZZQ08pkyH6UmZ5cirIZD3/6VXhZILiq6ztjO8f9m9IV
HG045JCkUMi9lmLrIL+r3L19laMxKY0off37tFQc6JroH44eBBQduUfwC9HxsmfhB3OngvtQNJuD
dWynZcC0aMjvhinK0zt37glByzjKLSFHdnTn+jyb+hk7E7bredBm55AQh+QE6HqmP/9xeSc1+LnM
qcFvG0f33SBRwuQwzX13+uuV239AKuu8M0j53Y+LOkgz6aPSRD+GjWrSk3rfzHQzO44h1LXAqTdz
Q7LBO53pX94KaAfsa1zIZt6GJ+z1U5RXDoN4lCG+Yvfkbo9Jn/tp6xLBYRJS9qevIA26lUxPrw5z
F3D71xcDRE3jylqETwNJhEuhdEExuPdCr9XN2w/UL6061i+MahjWTPxdNLxfX0k3hZMyjSIhy4gH
35zr8cBull2kUKHOyYsk2Gjw1He6db/8aOuiCfOCLvs6vbGO7mXsikGHUsFFyybamGlJ7qHJ0/z8
1f4zOf8nq/OLX/kXV+NdjHD58aV08fk/+Eu7aH3AgKgjbMAlvI7pGMH8e25uOYiUVwGGyaSFX+Wv
sbm56pdZ3SlzoXCwzBkvhuYfUGas5gceIaAnwPz/ZGjOoIUH7mXvmIk8zXzUkwb7HZORI/3dWMDc
ZIR5zSl3qQ4i7WnA8nwmRHTFEyS0WNy09kizdMWUCr9pLP3cqjEq+XNRJw/K6NA+pEFIkLbQwETs
eh1VFoB0zcFB6HhkfRUZhzq/K+MFSaGFG2yTZMv4WS1qi1hvdCdIhZ77G72XRrey7+UU6kT5uGv9
Vj7Oz32RODaX9qw11TaJdkai9jROcm2R0RWpLiwhBNuPVadtDT2pGnjYto7Xh2DgRteCuqCyuhmB
WhansdXR85KIdib0TDMfdaR/ZAfOkKU3woxtQVqWPueBHCVD/rHT6ySccoCmuzjtYZqokiYZb5JW
fh4HxSHiXFbqEBBYp1Bj6VH2Q6Vf8Zlwy/YjlCzgJTEipgRPX1zN9DQHwJr6gt0iUGvmgVsWiglg
mLABlrEWxuDZ1DGrwpKyc+/NZSV3kZ3lT/SjyI8XzQJiboz6AlH1qBpfjExv75qhQ4zlxrXYukvU
OmEd6/raDGqyHYwq7kcLnsU7zVJ45TtRQCl4GPQIYB0h1wms4nbpPqXjOHoPuqo0D9lU5Pkmiw1d
38yJLGgbajgcp760PlEhLo/OlPKcIGSf9aAoU21eLZEI2hSc9vlmBDQWjXpPLmdZLaQIlkZ+JmAV
M3SlcY94x2lRj7l6W3thu3jdxcg8mXxlnvoEHsdE3GJpzsuZ4/a6uWlpc+V7DkjmtJEt01U6ccSG
sgV1xkjYvIuGFn3pRHi2VrlkK2ULQaN5mQOrh64AerABqxH5RDws+MuwfUKSAB1BsFYFAB+WWT16
ISlzETOnuUu+a+wGhJHHzAh8RI3E+Y0RvMjAHQmg872YlgB98JEUR11PCahDhSQ2E42e5Lwysvyr
BnTkkjNPUe7ooabf3K4fsRN6FcmiEmbxbVo6+vXYc7oC/5aXQm9C+m2q2wUueYZ5Swpx3kYPcx57
wHXLdk1p10d7GQ5EhvF04N4hEDNYBsteOx6el58DMXGfYneA2TeoHKF2CY9bH7ga9tjCWAw7jJdZ
WOc0/Ej0TepBfhb0wc4XOx2K67Sgx3DtOTKi2RtZ3dqQyKsnQqSIKhRmNJVnsZMC9fCcJin2FYZt
67DM3bxjtAIjmQj422RJYe0sXVlcYbdh3kIrq/dCGjK033p6UGk4Y37c642O/k4QvJmtMLiP7pTa
+RbyY7Y3i1yMuxLjz+2IZRmYJc3PHzT48o9e1C7zuaO4bbcRJCTc9Ho6PqgyQaemtt4wh4KBxv2o
5g7qfh05deCYUNm6thaBlmQ92dlwPM7qKmvba1jsdYy6jnFtmLlV82BZsQ6AsZXGQ8LZ71NLZjLN
kGIykFLmNolNbqTal6Ot87BxWuUMjXI5xqNq5XexF5nRR7KL2sqnU1ScCOaxzW5hsjRtC9fB/lyQ
NjwHWpOU+U7r+/kHmYm0iM6swRmkvXWMnD42stmxvMaYi5NxaPLxEZ1PfeEUlo2CxEkWzCA01Ijo
6IfyPBtMZkWraZrUsKqdL+I+5xAZDerYbi2vMgAaRhCaAxCOmcqfTqliKzPJuitTTWwlhFdKHbK4
kJ1owroAJJSRvvOe0oW/U/a5kF8mQfOdFoE7sb6bUTp+9dzM7Ld2n0xPLYv7Z4xAzlcKb+3arhJ3
a3QcmEJaEEt3WVuNWYmgw9hLVFcdcXwuUu+JsQPhtDBP8/HE7dcux4w4FNN7kVUj3GPZoNltrWWv
eZJISisC7cY4jQQvn49k22GWD8uXnphLXDVeghqUcDAY3rqNeNVHbeQQXj0bCpTNzsT9EpEPzZjS
8rDKV5pCo33INVA9tYogFBu566s88CfGegvAMAn4b4jMOu1nQfuf8uifmB7eKo9u5GPx9VF8e1Ug
rf/JXwWS8WEt89fjNpp8JKkU3z8LJCxZ4KdXWwJlKw6L1Ur2V4Xkqh+ctfpZmwKrhmfVWP1l7nDM
D0jUkSKCkLBWaYn+JwUSf+dFebTKhLCwoR1ByoFiiE/4ul5HBjzgRVS1cHa68UKryXemnU4Cl19P
peeeaYTcuVu2X7CwNaCk/kyRtLg/vbhhlz/LsZdRR9rrY8PPj7Gy7kykscRrrcDol2fqivM8GQQl
H0OkSR5EEzA14kQ9NleCdaMvqISYWWdOU3weWltnokpawRxmdm7N+wEL/wVuGMc8RLHhGAzv4u7E
zgWgKRUj6kopN6v48p3P/LqyBFGDrILdcfV7OvyOxwrjLFvYjjFXY2iTQIGNat6lkdN/rG21OWXE
ZoWERCbXXd9noTJk9qFUXdSAramd0ujtfJFRycDVi1zx81X8r+mWa1H7d9H786Px2VR0c8xLuamv
b+egcus09N6hRRv51JmZFXlkaYdTYsht1y9X2bLOTTsd2TMy1j3QdqI3NZC473yS9eT1ywexEdSs
qudVR/H6g+Rj285am5BSjRYcwm0ZVd9noRSXVquM26jFRutHJNUgdZ+jdw69x8/U+vtY9E6IQAGS
guvx9bUFjiXNjRx+H0690IPlFJt+OmTqNme9B+jXWKjkaua9m3eejN/cfuJdVow4VJU1dOP1lbtB
RDBuoapVcQxaTZnowCo4sPcdaAfmZrRdsVm7o08r0bweB0yNM0aRKzBv3ntHf2292OufAJTSej4D
V0Gv71iBZi+uIAlY1UNG6L26TR0lw4apGYxX65W2sIl7PC8nItPnIVjsqXhsNIDODCLbmEPhvx1v
/yevOXWLyaVWbg1CNf2YJsnwlnKZtJHQbU2ODPRt2y1peDC5hjwumZgX0UOKPjuIiXH+mBJRfiex
ZNxKS90W5K4x8JNz8yDMSTnDvWFtEMgn+3bpo3cWpF+f2+d1ES8tzVhsdke/YJ9mVpyqVM3KnAwG
4j2HIF97as56EZ/rqBM+moNp3szwx/fv3KNfHh5wACodWe4TTUbNPnpswZlEUrRdyklHVbea3swJ
lgwPVcmoNOpDWnY6jJti+ZF7ybSfajdZyYDpNned/h3x4jOJ6tWzwyfALcxPtbq7UOK9fpCHLM7U
aY6nbZumJKMyn14ZgTXL2hn06OUaEFA1n1CoRhfLzLn+4MkWKUifTi7iT1dbrrqiNdLTqlU0+UmL
4k1dQTrfdmLJmmCpB4EzVZ2BRltGPDPDZNK4I7QKApzpFIUHGX6i5nznDv/yRpgo/Vx6fEyEWSWP
e55ZYdhWquUSC23f7+UwDnutYlYzJmPKAaw2tgZB9LVf6dkTfhll72qTfG+NXle+17eWdriFr3rV
ba7/z+tby5IcpzaGq61uN0x4OmBjhS/VTDv3eueuKgtz9/bX/s2PyeZKxwUTgbm6T46uaAxiajQc
VtuJgPIH1ajrbQ5E7lZXiwppGrEBQQPp8qxd6gYnp6WegOhOToDLOFdVXX6DmFDcy8Vu/RmK5n2D
lix0pHWaaDMi3wQl1d5C1COJzgUFCSecg6xtKM7T29/jiFjB5rYWCdh6qKpYSHT1aHMzFMOEc046
b98RaUjilNqHdj10n00lbiFcSovhyZD4qRI3e9oJ84ZcYOdm7Jqr2RTN1kvoTBaRbl+bbHuhlVoj
UybDvYhyQ24aVtB39oPnscPr3xplOWveuvbR5jjuQQ1eD8a/F+MWQ0D6w4AzxKBlHC6sGc5+EiX6
XueFwT6ml9eOMj55Ve2d6XWXbbqYPku4ZLNy5gK8vK1du79A3D9syL0pFX+KlvnTAtqRsPVqInC+
v3NiJT9IEZ0rRoa0aXTYYlVFyo+TtuSXb/8Wvz7E62sE9BDDGvPf4/VB713aWLD3t5zK5jNkCggd
DVlfUMnNhwiV1TvP8K/XA45PHUc7kehD81n7/mL0AmDDIBvYmrY6upHPRq98o+hIEVOJ8atK+yp/
p4T4zfVg9NGVYR+gK3k8uhKNLAn9GEZQqJZ55yZW/l1ZJufUQsLmu2NrvbPgHnUr12f7OeLEYlJK
qx4y+etVwcmzCpdmPG8bQXNnMBw6CW1d3owpBr1gls5HJWHfaVHvhaBhNQrhoUJdjupDuxycPr41
etoffT/Z7+xLxweF509mwXbH14KB7fitgwzjKV0aTVuvMPJdNHvafRwxpEflOHycCFAPS4Iqv9Pc
RGKkV907Lf7fXR4JOJUcbz/v/tHiVRP/kehdPW8XNZ/u6OFpX4jO3SkrNSrsu974X5ydSZOcSLpF
fxFmzA7bgCCGnAeNG0wqSTjz4IADv/4dqjelVFulve5Vm0yqzCDA+YZ7z40XY2QQ5XVXWRjvbYXe
rMn+873sKmf4KSZEn7c3XhCQS8XsWyeqpWY5oP31Xom47iOSHYlbKTb1Gs6NIAFGXHIZupfBFPMD
0Fl0DWQUVWi8un2KVyAPyacm+/Dvz+EfV4fJ+04TYlpOocv/fr9t/Goif9HsncSnFDgPbmE/QCqU
t6gT+s/ac/4KdN0/S56qpKmU+fLvP/3vx/y382331rP3CTCW0Kq+rXdzZlCbEyonKfLBNp4NHKQf
mN2G+p7Zu+Mix0DkGmWL341HVaquQN/TDmfClyDikFg5/r9Lf34h1guglcCk8KnelG/oOWCUlw3p
qwtm5AMAbgZHZjveLSh+vghrvJ2Mxr38+2X4L18C7HJMJoFNZ/4HcBMPK/ZcFhRJiVaYRi+crV+j
R8rFWvvi5CK2+EuEjXUeg4I/g3vYvVfY2G9rCgxZ+2wAYwGxxFyA32+DRTK+k0yQkjF1CLOBPb0R
rpNr1OqrbfaM7cyivqyo6ZlC81du4Te1+tEZrVnFzA2b/eYl6P2dZ3efffxe6/B7scLGMMb+f7fj
/P575QhhRwvJYJIy9c3BmfSzF4VianSES2WTR1T/7RKtXBjiWlq/dk75rNDnzfnoXxByzVClZjtY
z6HVbmHSlCvdgzMb5BB2m/Re8lwXOeKwaUtPStt1yQTdWPR719f743P8bQKlk2WbZZLe/vvnGFrI
hh2u92QCM5We92kJGWtFz8hBznJFkt5kxOlIBwRhlKIeiskRFWYkStcrjwRHruMJC796YIyPErUz
hYN2f1374p3f9M9bEYguQ2i4iuzR/kyxaklwzmsuuMHwJy6r1buMk/mpt6vwzs4J7Ax6a/3ude1p
BVmc/Ptz8MdLkwKHAs3fl26oWnaL7T9nOe4gJWKBXCShdoznssnmR1+G5m2JZulgDmn/jj3o7/Lp
9+MHOw06FtbNNm5b8eb2YsBAYKZ0RCJFM33vDAcDJD0vCB7XvEVx7rZHQk/0mXcqWryM9XPJduFi
VxxEwhjr+3YTJUQcqW6cGoMAwPzeODZgy/Hyb8FnKToXVbKivlrz8Z0S4+9Mjze/Pa/6HQBHnYHe
4k05K6VZAMHOzaThDr932BG9sqpRN21mZR/rhZ6XHYskYgtI/C3KTWS72TrGHYExTI+cYk56v8ya
d2rWfTv75pnFbrUTaQXGXAe1y+/f4sDIpO02Z0tS8JQq1rz3yCu00+5D7rtp+2lBLdheNCYRGbn2
7LfHesJBP26OuIJQ9mYiUg1WeWoqhrtwtbM00cj19Y3uwxkOxZDP3m2HR/9/+cV3kA4UacYeYsfi
/PP2407AzjIba2IFyw5YD2vdHMvJDx8b4adfmrEf8bMQaMr40JkCC9aEpb9OADez/VXt7DbAGWpc
rhoLzZrIxHlKl5Za29wrbmVN3pMURIm/94v/eXrztmIVDSNmr/3eulB1t1NC0TDj6jYRAWaONX7z
yuDBQsX41JCpliAMNr4CwTeeMluq16DFGKGRd9+z/Qnv/v0p3sfSb2+AvTUFws0On0Xom4prdGa6
Dmp+opH0mmSpM6NTX/Jr63sKYBVJdrGS4hqwW7ySNb7ckyVbs35bLsJes3cSmv8swCCQUONAH9qj
TbBw//6tsosv7BoVeuLn7alyUhbYJqKrZ2I00n0MYd84GbzdkXDaW3bc04cFkWaM0QIB4LQCqS+G
7bF1d/uSmqt3yvb/cgLRAcEjJMSFt9zf+4J/3nOkCWViMPstGdLZcO9axtfsutO8ezQWyKhR5eRS
fDJWYzx5tqFNQjtXZ/mahxkFUFXXQLgkcmHrjvkZs+TU8zs/DtLAXCOj3GR93ezGaeNOwOCNew/B
dVJtOWVmTtfy3qX+L188i4W9mmQ4wgHw5lIHHa6ZopytpGlg/OeSUAyV+UGyFAiJD+ivtzvHpo7Q
c/ZqcE0enaHwz06YqhMUXO+d8/FNIiOlN9NjAR2bWbYj+Dhv7kOfb488BO5D6dfbBSF/c9+MfBsx
Fsvt4I6OdRyxvkcNxtVjuqwjEyVlPgagZxI8SuSWjMjYDxZnBZ1JFoKbk86A8p3VX7TlNdIN7N/G
q/DwM6laFl97u0+I+Bi/5+1SfKlq4X9859ly/ni2aGFtPo2FXhHk/P4V/KOPHYpyhZflhwlSRutB
WqVz5w/ZkIRNVX6bBbmqJAF3R7gwK4uNNPyZZ/o7X0QXb4Cgn0cT6uX/8CvRYHmccPtk7O2Momin
0S7ZtyQZg6JbmFTdLaiEESk0qlx7tmDOVdX0OeStdM+5sMYLRdzBQBNz3PgoD8i832O47N/s729G
xnQB/mi6GyZkb0+gWTmwcy2RJu3q+Z/Wos6JzvTaO2r6+SiN1vjgKvLh//1C/Jf7jZEv9xp7MTYH
lBS/fzelV8xTHdA7yB6PFYNP+zw2lTgVql5OaNnqG6gZ7ed8AI/cKdP/pZ3ym/TIhjv4jdeS/TMO
qBVColVsp7nxbOXfGyQtQ82Dd3RowlCdQHJbR6MwqgsSjPS1ne3ilRfNrTK2Qbz3zf49NPjndUT7
B71kFxczzKVDefuJKmQcvBLNo8p7+DYOEQsA/GxPvBahvS4xGaXDdhjZSGTQTz0ELs5kh5elHpVz
cFdaTqJ2wI6T3Ovo7mNjt1kW202BCnRRs2nfryamooNpYoH4uljVTk83g9PWrIOKEGK7WVw2/qtX
yvVziuyS1UtTfmwXExfmJMl/BpHWxAbKl+44hWRkHgqnR5qS8piUh5H6eKJ2c/VjOVnA01ZJZEvk
S3f56uHV7A5bmaOHIfi7AuuqMn0kstzauUUlWY1+b2yxay1GGDcDyv9D7wNRvqSuqe8JXsZGtnoO
Iis3yJ2oAO70kyBFp0gMiAZ0rnOWzTczVU56tuc9s7O2R6X4gAaEMiqE8olBzvArt23im1Y+XFzr
dYMdNrlYsLAubnjxVH/vSmxkJOyp1gGzZUDYnXS42yBxJ1l4RYyKXsFZjZspHfvPaep26KfY3tIt
GbotDm1qhhiKyPK+B15O0EeK33U4I7ydAY9u45A4Aeb4jYRrF5va4DyEajXMq9WyYzuWWyX9WJI0
SA40HPz0RFB1Z52cUqGNsSaOw6HcL1RaZmbE00jUM+Yw8aPum5rsq39/xP5YSXFDcpzbHlUFHBs6
lN8fsa73h0ZypB9rK7euhVk2iSHga9pWn985Ww0bdCVgMbF4ieMXcMoL/aP1Trv+x6yNH4BQfN+0
gMqg2N27vX8cwqaLhiOgYzyuRTdeqjLNrk3hmccqyO+zSTcXJ/NfAmWQNM/ZfFOjFTmvIjRIFTDD
YzauPnOgXP3894vztnv6z29FjQMhit0Eeca//VZdz+mPeCw9Dmutf1YExUfLJIbHGRHIZw8hSPLv
P++P2oUTjk6NFywiZHgufxvh/3EZunJGEDTM4ggoILwtdFpeB1NWX4J5Bn3m9TwbmdvcIyHOLgob
CjhROe9tlpWD4C+JLD7Mhdw+wpKvnz0QOy9e3SlN+rp/Z9YTZwTuXnEIZ81Sx1SW+d7d5Hp7i/Tb
AUdhiP+IWgMJO+XXm28ydBevQ5WZEuMwbf6xdcUQXHqiwKooGEac+P4KDxUU3KhOJmKxl577LzuI
aTPDRHuWvsMlrfSp1MvWxtZMU7tLedovuSrQm1mivoySjLPIapT5LStL6u65ycny7THjtOSud+PH
oXHhy+JyPKVCe/JKItTQRHnZwlaVdUAWWGtPPu5FeDmfpQ8lMOpHRfYrwzts+1ln5sVZ6Qyqf1uQ
nHqcp7ndLhkmv/ExxC0zRAXo7eveX4exbQ4WVLwha+dLuc31964r8g7/NnjJ45438F1MfVOdF1U4
ZQwYnsJxT81QBz+3NvdabKk9HCxcBrdbyWgsLjO+L4Z2ww8OiGp8ZQgzfMfn6/NNTpmkncKUVF+b
rYHwu8ys9eKgJuQd22nHg2DmiDKKedPfXHOt7cRdiqLmSPMtfZr8fcGE0qXJLsTiQLPzWdu6x2rM
RxURq1tNhw7jN7rPZfMIqaryQJ+tLq+aq6hCIkiKoSb0uNFbd9ImEU62zdG+mt22X2v7OW1DCqIV
IVZ5mNPK/YsDKHj0vHDqIsIgCEtYGuxjGz1EgrjVOTMX619cZySSOW03egmn8EoPT2+FVNOoO9h4
XqnkAam6W8QSlt+XIDfCR1VkoiBrrC3NI68iOMBpo7bXxtCDRlbvVY9GO84DRfs83y3kTQ8RFlYV
EeDZqHO1FB74rlYY4Bsnw1+OyjAbG2czx8HBkwyGDzACtuqFhLr8njpfyOsSZPNJWEPWvOCh72v8
TJXqX7EwTOpRCJI+T73Li+m4AhX5URb0rpfM4515JC3Y9Y9+2vQfjGwM5wSYT2NELSZJlTAtJ6lC
zi5TsjHPh5u261Y8mKvrC/r5ck+7blWYm4fch/f66Mx5ZUVOvjYfQvLRqtsl4CLEIi3NIfLMYjrV
NPrjIR/cYDxhBNTz7TwTWh15ZTkNTPWyNk3I/AqKpN266hlPfT7HDjGsMWlIZfOorBF3VRFM2D/N
xbKbmLuxBCE9iewOB6dNnvm25M9kQhHvUUxButzaytm6F2Pb08wqnk19yQfh4Fbf9GqclsaDVuQG
k2A9BjOtuN1WAoaPPOA1n9rpluq02WUlT5Y/w8pkoF//LL2uAtOuTele6272Wabw9/szvvpwiawc
ByHI6B6zwQ4egptAhu8UaQay2wO3XgdBSbsrcYWyGpLM6FeR+MGAkEpZQXeujbTnUKdrocnT4VcN
JYz8bQtupszFcMsXqdizl9NymUoDJGga5OHLQPyVeORAIUClGUE6kFa+r2I0W9DXSsOZRhyrCMjK
JoGwG0xpCZHZK2FJZJSyieUO6RZvq8T8uGaudg+4zrsqAk9iEZThruFLrciavJIV6b1g2tY/vAH3
IaunuQ6jEGIqkABdkT6PKZUtm8H0UR36YRu+uHaHxrybq6ZH+9thxTesqq0PvE4N4jHwBeiLaRfT
dNR6yD+Wegp+amRtH3d+UB95hocY0/SQBdwAXCQHZKp14B2ztcHlWE6zaiKSScLp4Ii6+J4iahyP
m9Oqjz7r3uGEeENvzPOMbYvnzHCDU9WKWh4t6BLlo+SOge3vNt34JCQfNEHsQsW42GWuCHNcyDML
y+ov5KEG6fFh6xVIHbzNfTLHbryC66Xiq9wNyrbLN+PfQToHwkHiASr2KeecaEEhteSeWwMEY8+v
zoPKhIIuMvGoM8nWIaSK0Rxxtwbjk9lP44dNDekYKdxwxV3YF6o7jswL7A+ho1xCd0qvualpsOyj
okj6aKyu0UdonbZbJMPqp+MMCPzlBnn56IhxBCRubGhYt1wO/nPmhUYae56n7dOy8OifFiriGUb4
gq196GpgImztnAvJnAu5lySfX8qpb18UcwALwfBYr3dLbqiJm9JDtlwZliaSJ9zqMu7FSJEWmDuA
F6rGdoQWAbdgmKU/HJghjQJzZLDI2PFaj9hOo8/O+Uio0yHNpsCM3SbgBpYqI34BC29zNahOIy+s
B659s3XjabVrVx/8zrRfS9Gq/CXF8B1cpkqHw7WV0zaeG2pTKrZxeu3Cqrth/Zw9rSXP6BGrtPVY
ytr/jPW2XU6lic/jbm1BKwlHSYm5zXa2h7HctB9h/AQGWKLBllfpboAN+CxLwT4v1yJGGyyp/UjU
QxLVmygzCmT5V+kjyuUdndvQECfcIs4W5s4N94FKj61Xjc96FqhwfSE0Jkf+3cChv1jiaC1OFzyx
O1jaZLG68KcsAq4LDgFGlLi2OnUwtLvhGoeU8aw9bMSXZfaWm22e9RSjhq/xn2wZb8GRisBG1zg4
Ej5GzvAtnJh9rxpJXVzqfs2SosRPn4z8kXOuZpdYxHAorCucn749NlpWH1cwwKT7MPdeL0MgqhVz
cq1rnA2+f80xmTtRgBPZu6T+hvoD3s0QheCRgcdxWe9LxIVBBP7YpvihxLpZyQXj3VuIScYbJl0T
RIdv3bS+sbH6zNSy3OKhYze7Qesl7zRYGZAtDJivabnwImzYhFAV5Ay8HLX5z8iOwCL5XmWGr3Ul
tXlfszaTNzAo/e9o10LyeVooDwc5DE3BLCIDmtTY/fhNjm4JT3Vy+Gl0+dsXYdSiO85zOMyk3m3K
i91NqzFynK3Cub7063Ox+tt4rDZj+QGAxPyG2+Yp42nh94JNvkacLgyYJqeaT37XltPBbE3nKV03
e4r2KTeSPjZQ1p1RmJiy/aw07uzGYF4OW3g2+BmhWZ/LuaznZHFboz/kBHLEdT+vuOvXILiOYjKM
c9FUXBvTqrMPOdPXA/PNcjpr8JHZncrIHOdOqZcalX0LzqAYUbVcmMkslxY7zPi8EVoF03br3Z+i
kYuVUPMZ5hPmXtFGPO9+mtSOHJ/ckEXUcS4VdyolBdVRA2wJA5NKi5BOfcvaSPZjeOW96o4EdaZ1
Ey8oYedzY2JbTDg1fHUcqhkwFP6u3I7EzEjunOqVFMN0ctynvnc0ZipdGufR0/0U9Rzkh8XXmvF6
1bldnHpd4F6AIUCQyY2BhIEwGI3zBBpj/Mbg07xrfYVLBQgQdpaMsPWWXDl/Sk9m50vWmpZTknTg
WfV8cIDx0FZLI0zy1li2U1Dh8zptSknvlHauXx8N1qLFhQ/op8/thEMcAVq63fV61fLBDWZvQNYH
N+ZUrrb1i6GTo69LV5lG5JqdcZwrt7aPYlxYUNYqbD66uTmKc5NbYM82UlW/4W8QwEsMNATxCORm
uNcGsMeo7dysP2P5x0ea9pZoYx52SDp7AF2dTZGz/h047cvqWwa64EMVBo1G6z/55gETY28/ho3i
TGePBjjbNxbxpSzcLHjsOrLViBwuOYeCrpDzOe8nP/uMR8/Mzp5u5AM2Cru/4QRnDrPH891rcp7L
q4NvCnUbK8ItEgtZtkm5ZRburGyb9G3h8qDeOhtjjgfduXl1ySFap0ebTcOj7HsqDIkp1j5My9Cy
14bMp29lOLnyps+lLpBDo286tWryKTBUbsR9u3Km5o5TP3PLo2jJkcSiuXIrQROW926bAAerbnYa
UhPPQBrF0RWdvrWtlCaCd7Bl3WXanFOmL07wbZRt6x3T1Wx/FGlF3m8R1N0lbaw+i4kc9t0z/Evv
uXd6uz1LF8HYkYYF8IhsALjhsjWzDXjG4mTkeGt+k0X4pY5gdWzfzbzc0U0AO67oTUNyynC9gKnv
eWVr2LQj/jhn3iPz9ljbnBXwUVtrTr2Dl/dn5s4svpbK0M59YfjOObW3+ruzaLrSRXcBQqmxLcBG
GHX/c4HtkF7avJraE1B5QaPfQyI66LbNu6NhpFmdhMbcMDPEyNImgRDewVW9cqO5TJXxXDfjNl3L
bdfFerU7vO5Pg45gtkxjVOis+8i+sn+xuKPz2Nu6Am5+sWiHsxm/S1RltGIHMyB7Haehm0OhUUBW
x3bJ8+MoUQZqy8p+afhC5U0/9UDNiQh0rmMlav9o4rrLr0YRap30WHjc2CVCmvWMs0eQC1qrW57n
6THTTRAkEHKab1ahyvzU5a5Z3HD2jk+aVsI/jkXt/egbbRlZbG6O+UKMYH2Tj1lzZs7dRNQnVssC
0jHFt5CswPt8ofI+1NWwJFlb6OA1HNH6xSQ4s69QJq3CkYm+an/5y6qao1IWoXDEFBCzNwXu9gpW
q5svbJTS27rzBz8qbGtwY4kMViXY4ehnhyyvgqMPdmQ+5CC5igTyfmPGKVCNb5Poeg/n2TDAU7f5
N05p86FrAemOgt12f+STkX8kxHn22SB3ywtzO/k8ECf7F3cFcZOSCqk5aKw/24VSfpT3Wdc3eUyS
RvVDWVKd3VVUDnnQBvWBWGW7xq7QanlKqS3M2LbbEZF0LWsgNlZv7Ti2bCKVkAJO3MqtsYNbAQCS
2OaVIEyy8EJmBoNgJxL5MPh2dQpl6oNT+2EHzX4tZioP6Hjxwtju2UXTtcTbvBE9wONCVB7kRTut
H6mCytvGDYzpVkJyOofUcfads2Lyonquw/wRXOBox+1szOQg5rZ+hivPwMBxM7x0IPVb8YEtTzMc
Q9SIGDMyIxyPTrb0zkNXrt5pKabOQa8Ih+rMExN+cdCBHlPk5LwEKFq2S2iXHhN0m0DiqE/lkH2Q
UIiAOVdZR4lZi6skmG+NzZ4M6GhYlZkeKa+t9kqcfC5i/E8kg8JHC8+BWHb47MAUyKnM2b1X7QZR
EBcp+9+2cEhwcAkfvTFXaX7Dzog7f6LSuaI8MvV1XdrK3d1f+e0+lsoOlsYoeuwDu/Kfw5UJf2X5
GrVKZ3Pqe6JT441npnMLHnJI2UhtGXFjrrT0TSp8fPnEQVhVAuRkH/sio/QF5pcZJiR/MTAP6P1y
GIxDGUxRQayPpQ51QQLopVvLsLrxutBkTh6SUp+3eZo+4Y0j1DSV2rsMuJgJV0zT+avcGDAkPRv/
ldRxwkgfZBtW7WvYT0Z471QCABizasGwHQE2r8lAfxnChrcVRRZlQ8PSN27klNHYZNVM3mMn0uYx
MKiYL0PRpPZFrG6lIgNYMIgkS8n+vGz7mWlUfUsmW0jDfAnKyRvkwa+V+XGhl12Po6b0Oc5W120J
2akWFtSuTL8VRcA5uABPLtg5oLwHvJgWL7xkfP/M7tmeztxW5oR9hbHZjeHljvnAVRbfpdH4aeSn
abFGQ98txYO14PiI622z/qotpvJRBTd7fkq7NJdH8CtLQ+hS7p3Ezsy6bIvem0Q1VtfCbXD1WixO
CMLdrOVzrkM9REu7KN6DFabVKJTcrVFnyTDSDdODeArQv8S5cIdPmy/JOudM8kBEqZ6zAesgzeuE
slYmAyI53k3eMo3347ShekdYM8babo38bsFoSuRVIIP+Igba4YemMsuPS1sW35wZ1tbB7gmNPduF
H8xRJUy/v8wqt4EQKS0/s5sao9HxZ358GKyvW1NlLBboupcrnc7EBq+d0mOztA5O3VHJax5CeIvz
STpW1PQ9GVxk+kl5yMyiuMOqk94UYhDdrVkPuxuznzv36vHi+DKyMd3zW7T7PWTilx3rIt2haw5T
EcKhIHrtuDV8kOZWbkzrGE8uNyFY0u2pK0Nk6aLBpxIpJvKfdS2K4YYbU3MgG2CavzhqqD9bwLeg
DfOMug+5UWxelI7rBGEia9u7Uho1SIvRLlB6+HK4Vk3Z4Y2nlK2hIipmgT4Up4lvgBHPSc0d3hec
2NXPWfgCb5QbFL9o7Nvm1HXllt57y8oOtsFK+31uFhP6q2cF9zLkP0t0GUSPk5UP/D55Jsv0YONh
fkIC6OKvl25+ZEMNGRYRgjbvrM0M1pgvhULcEYbzhFFaWJTHWfgTMdxkHzMN6OeMw5bl4Axe7lF2
3grZlokx0DOqZgpeyDn0T818M9SbzbxLSMkLbQ1TYlCsFQyrwSdao6ktczrunq36gdU3VvMqF/VP
lDbbhbQm6zvDQXQsVRrgQTM3KzZouHDItqr5vG5ladM2rXn6CBbf/lIMiy9jH0FjFy+TMspoSutx
ocPH3EGxRVDOVZrKzePOV7+YdWvxFDqA0hJIh8bw7PB28o8D+pAmGTYRgLzSqVPFDCVC92pOm13t
tS6AsNAIannnNHoZYl0NmREbOS3Oge9aX4BKhzIWABYRmI8b5dtCt/6iVgYaeGz7pb52sjfvRqfN
X7TT0ZGpYC3od1qIWeNmAAWwh6AELxVQYq5w0hgedvMCLSQraSNpa+Rj1onahtQYAEphjiHu3CDM
++uee6QS6ZiNvu/CQQz3plg9omCmdaansQg7+TYZpWQzGejhBFzM/VB1pvEVkGFJThYKgxMlYjMy
Eum6O8Spa3hJ0aUWlAzG6iXhXFRtrKoK3KDljbO7Dy3AxjHdA3fVo7cWD2ZTYsOB3rlK/tWy+p8Y
Ynb1sXfamllLXvf9mU9cdIeVHAsFghQb0bUnUtJ4KVLH3K6jTYLsOa9KP7yIYi7mOAtMokeCXAXG
ba7moUw8rQmpwZWdbTdzQ43qdN5MqY1VtaeUqCf7ZKwt6MSDEdaV/dD10rxQWI6MUzd7eNCUTdZZ
17ZAwW6FFOEhs0/1tVdIZ+515ejqunhgzdyyEN+RA9sSlN4ozZMPLPg1xUn9BN4SDJw5mIqeYSiL
9QaX59icVOZ4kBN5qe9ITNRba99KE15yM63YzFX7aTN93k06AxkRK48En0MGSUvCfiO1N3YZnH0h
BTz4JJpl18injKDimo4QpK2l1mNJOfy9BRb73Wyn7Gs6F2o9B4AsEeH4df6DGd90cfVkiWQw05Vb
M+w3MgPCYnrBL5RZoMlrn6xUvhlmvtKGus86aNhHoaYin9sbLnZhiU99aW4/ynwYh4vqvFYj9qjN
IuF57nwgHIzIY2seneUMvVWLmzbcx59MhrW8sxZ7bo+STxWcmnkwfzJlddPPoi9a/yvL2zW9pX10
60NYWBDwyqZsgucOUZJDpyeW+advryH503kWOrGlXZSrBXei87j1FCVR6eQMwqnmlJsUvqggT84s
ANkPl9/aUKI38lbZgAZwxanKNZhKuTmDc9i9IScuBj+mt1J6fNsbmCUMXYhDoUhXRWAiX051LwXY
v2RjKf11XrBWPGIVggZniLkUN9SSU+zzzjkObpMbSc+gTXsALdLUP3tyrn90tgKgYbhdM/5Y23FC
4aPrFczCkM1mhF6Kxn5tavh6zAHK8E4yuXpKm9LvWJIh+IhC9iCf3L7P19sUZ354Xqi1Yl5RvBHg
ofDuArwVfFSpNXVH0ymqc1i4oX3Np5H9vpNnNjyUyp3suCzIeP61eFuxJznJuks8IJQbCJJQyi1i
QO6mqJUGfc5btmWxRvf+g3a6WOPVso1fvI1pqDpjUhVkT2M1X5qNu+d+w+VX8BCH3TnPXeHfNgMJ
vixRmdhHoirbMIIiYdjA8Nb+WTUND2xNWHgf5bILgmM7FnYYF3lqF9EkCfA6QK3kFk4Dp55ORs4F
IIpy1thikUuLo1nDhDbqLOQ/YPqNceDAHmJvLRznVJDoXUcmskkRFy37b7KReLo+62GT0ATrzEk/
sIBrH5CLjN5BToQq3Exz55hRjaA7P1VjGT7gG/PJsMx8m8TtMQMJzh+QKY9t+K8ALxNgvW1xz6XV
G590z8F16GrYCTFndJrSd9kcagyXTQx6SDqeM8nSmUjL1LkYlfbaCOeo40eTcrL7fKyhpM8rPJIT
V4nXzZpaTcjLALMdD1jAeM7xs05d0nmZpwiyHpNO5ZcIXTRxpmh/gQr7McNDo2BPhCY+blkET/Hm
DwznZmvpyQ708pxWY6jbJ+yOVp04xjaLbzDM1WvP0fd5sEpgIFgIe5uN0ejcSRssUFQFy/ZxlX1g
XREEy5KdwuwACx8c0zg6nZAKqDwEjXjsysA6e/nW/sWcgWtFdsf+OBH0VceVnXcwROoqOCnJai4y
q6EKTyNCZvqpNs/EIVPp8hGUW/sXkFvNQpWtpYiclFB1jcB4iEhTo1/pIXeQCqAD92buu41VrMHA
7JBhzaaQE0r6J572yb2hWsVop2bP/0krBKR4DNbWo+OodHDFgYWGJG0LFm5iHgjvA5mNFmaxpgLI
Dwpb5qK29VB13PIR8k0OytyXqAyYMg93JuJt89hpC9hHFXZrIqt0hvvBX3mqa4swdeI6SnnRbSVv
TZHP8tbLw+HnUro1XEvCBqorlVvF3AI/flJyEk9JU8ugONczA5yDhLEsYrlp3TxIYSJUavmc/kmg
YXWToGIJyBIhH27ZHzIobNbU/lVkpcPvI6rFe6kGJ82TFJZwRRtbg+3IJ9bpB8NhgB0NxpqasU/T
6hAtFDCJsfzKoacCW3DswebxNlyIu1VLZxIx2fvmV0L6SGRk8LjM72nX3nqH4a2hjtjtH9D8MHu+
MShkpUnPZk1AaVKGSoQc6XicvelqGvmMgbDNfmRmurCqtoRKmHxYydKC/qcOc66rD35c6s2+TgCn
zmU7VFEzj/JDxzNLAZ9lXwg08I6uakPwKWmlPvy7EuWt4pyXDS67HUMIkBKa2xsVR1WvlQ+8fEla
/J+HCvTQRQoRsteZnUulKrYoDaGLbcj27h0NiXgryMQRvEstwQqyHub/v/nZbKm2wC3bLZk9Wz1M
Hhq1dCQOFYBwaFaJzxvr/yg7k+XIkSzL/kpJ7lECKAYFRDp7YTDYxHkeNhA6SVfM8/z1dRBZ0hKk
p7h3LmLh7kGaGQBTffrevedOyMMZfyf7NnTHcNs4zuzsczma5g53AwyHWOROe2iqQreRurv09jll
o5Eb25TQJ5MiOz5jo1M37ZiP94kU43JpxImbbKhXx5QivkLBPBkEhjPQAApGoUePLrCyamh20RAS
YCOY/jBhYUpjBw3UoupSZXP0FNvWatKul/g4aQP68LnuxocYd7ZJCET3AYtvJN24LZ5QwfbXTDqa
QHeTSaFrGVaCbNtJYKBoS7uKUxqXmpvkxDeUKEv9FiWh4271jjEcwH+RvMG7F6Q5UGxrRKXXPdbw
1rI16Ud2mX7kS4FA3ZhN/bofQnQvzG+T4TZSzbDsDQvdFSt0WL7ak4vluC1H7RXpCvJyXUVWTy/b
Anyt88Wmow1N2NjlQ12/JA5Qiz9J7n8RDq233QE3shIiVl/jV7GVRbOX9rvE35lp3Y41FlgWfqSj
4PIHJgyy7SiX4UfjpS+DU8efVpjLXaGWC+KdmDfn1nA1xrzn338RfrGErE+jbTEEx2L0lz/869uK
6JkIeofTDhVKdclmpj96EJ72FnSWO7jx7b7madjQYYAZNEDUerSdMfRNVLu+ENGQAtPKzT/o5b6r
cXlTfDW4RkKixYEt8vVNdaKqex2X/k7LKnWCM96vJ4U6OUYsiuC04uhoI7n5kw1h/eZ90XZBYMDF
gTwNOyzsz29aQUd2FE4W06y2oqsdNy2VZ2o1l4jp0ZNgeGaExun5Tquz+FRbwxO/prjK3GI5KEfq
OxJ/vWs71dtgaVJqpd/fqn/37uB7sNY6OOth3H69KAZq6JQxqLFjhb0a06JtNyQ01BeVyPrhD0r4
X2yWVHuWg84NkwFPBpKPry8WMWWOTMIpVvGO9aNvazDIXja3QTfo8YeYqdWA4guSZar5oih1WuJZ
JRlPh0vwn35sCbcIvyeySV3Cqfj6TjqimkcgW9MOYlZ3m3J0p90Ue57v1kvy8fvX+nVbcAVKSPDR
YnUff1+aaU72yCuiZWfKioO5RB9K+rrJULCEcczCk0bPvcuJv6cY+MNr/yLGRKLvrVccZSTWffnt
9raTGzJ24pnvYyu6HXMmAK4YcnPjtlkbEDBMnOnvP60Q3593zPS0tAWeK2wPZEZ/vbQVBxfNjQUE
fmNGu+JCOIpYlHSg7GZOTU8Y73DslaMPqP9SSLFdYZR7Glgc8TkS6cfCtahIxqUw+h+6lqatb2gL
DUpI/2D06V/kZhBSJcINyzjsxVbXtCd7GWooCkvJYOX3H8j4fg1tD4gJnGl7ZdDw0HwTtHbpxFNU
Rxzg0Tr/4LyzkCGPbfGe5b84q5U9vtRujcyS6BZ3k8uIiIvUo5vRrA5Ztl9705vQ9tpa6Rd9r5mv
ExDJP4R//bs3uRYeGBb5D7H316vOVj/lOXPufV+W0tjB/u7nB73UZOzr3WS0J9xvfff2h0vzvVzj
0vCIkk2HkFu4GNu/vir6JR32oFfuK8KxwZAPFZWZZd9So4XBwsT8wnTC4dDMTE82Y7EeGEdpqgPT
6D/5/ezvK5mzksRc1pfVN4r/Z/33v8mAlUYGjs78aR8aOvq6EnngGaEE4sJO1SLPK0fk8Rl5SaAK
+UaExh4LXiKPDWcnzMSSKcbGwxZvbrEyEjuB4pUhBiKyxjgbKoPWzZy1/I3etCzjWtralwxYsoVI
K7etj6NgOduUKtKjg2ir8NyLUXBsIN7RNq4mETcXOSoHeUot1rlTYqQiPLcXGmzbdqS/s1mpyTon
WDmTMpEBx9twAF1KClrOWOeo79tnG5bM/KKWRE+uyqagoTu183JWDbHnnJlWY5mXokPJFNuJ7pwr
HrXMt/oIQx6xARyM0eM6DxKTd7gdvdwer9G2RZNP+xJrRIMTdv+Hx+P7UuCw3eqrYwNPPyXx91V2
zrqCfuOk73Ee6CGQAa+KN/Q98ZkpXYK0MmvMf35t6+6A8ykip2lMM3f0vRDm5Zk+uSOin1pvhj+U
Ar88KwbvR8JhWlkQ6Oe/OcTweerQ19S8X7Iu2nadqnCmpnxb1WpV/YMfjY2UR+/vJQD0DcwoEEY4
2lB/yG/7XjknWt46ndojXZP1qgAzyquwrNOfualVc2DiikDLlSAPu+m9dnz0ejd2Tz0NQnU1DzhS
SNtUtv4KPpTz9mSjNrqh/xZdejm6Ol95arBIGHVn44XIgGy6ryOSQCC3as2aT9Q2egBjsjW39qhT
7rczMKSLsKTfjpPlrwteQgG7XHSio/2eq58EchpVtg/TUROKH7NT45Ggkmk+tK2VLQ/SQP+9GWvL
ZK4H0YRQlNQr9paGp227zkefPSN0P7sypIuiDAnJTtGVo7ArulkLALXlryJXxl43nNA5ZcaMDBeX
Vqj7dYpxCac9SBNqf7O9QsPd2MzPqa32TMTyaNtGc+8wj1J9G/QkRoQPLVP7vUPfnbTOOS/fJ1Mf
ih0ipIbQzKiq7z0YrsxbyZiB7En2ebV4Y/bO3kHHJ/fMPn9mTCNqv4ti436eYoLbKYfM5qlKbXVU
HJ/yo0Vo7K1ZVg6FCcEd4dGU4fRhsrKyxJd45ImY6ft71yRc5TgyPTS3jKnb53XL8jY1EtPIJ0zC
aMjEitxs47iZ+dPIBLjiMu7mzwIZ5Z0JYlV+pKmLHl2LaqcANRqGaYK1e1SKAPY1jcngYTmfaUim
ZJyOk7ORLubSAL1NVqPACvudBdmX+Woz0Vdk+MMpBu1Pr/nCjXXwacB3iWc3CS7mXdi6yWbKFcfA
4iYkxXNgXXzd6IsXAkTolMl8EPSznCp8ZYNcILN6GTFx+3KSdiAStDcHNSWzeMQ9i+VYkM96ImQ9
PspBW9wAYZ+LkZpxHetZn1TuIQN3lG/tyG0/p2Rg7pgbinNkDc5BI8TWYu6Aco30o5oNKNpNCuzW
RuP8Wx7oS8jiLCLs4mwEnlif6LFLHFmxjEiUMaP4R5cUSYXXeAQCZxhxThphY5RML4aF+F3WbG5D
VNgWWuJhLsSW8aW6hhOMESRGsZduNXNM2kDL7bnyTafN73S0zvbGKKb4zB1SC/9A7difSyJo9GNN
cSt/LMP5KufHidtbUeJX9MhRwqhFu55K2bxx+ne8tTM18wTk7Q8rXWyxo4zirCOxnPuVZU2ZP1t5
JRkQRwPMo8HwfFHklE9jFAoVJOSTnhwjNdKg6Ab0dlpe3HtOMh8LdAQfiErqo5O6ZO9gokitXQWF
2zsWJncQgkmG6BKjDIm6GufYxU+scnY3TArN81jYHrs0AbnlprPbCqkOBlmKb+AKp0Gro0fasX1z
obpqutWNTAK1zCvjHE2n1mznTtbFOY1LgJFykTK8HcUSwbIma8zeIm3hIXWbRbwUhk5HrY1xEG5o
qHG5C3SLmMoMpU/bhjJ2CsjhnRhegaprmHmH6bWWZdF8mCdaWyjZEtGh8qLTgYcHo8Ims8OOq2Ev
MUojT63RTKueR4ZWe15U8TwGYC9jk060Vtwg26+fLZpkkpQQ276Nh8lpfBMq99my2uc3OiWCuZUp
4pFNPaXjE5jvkJQqd7C2BV6A57wvl8KfZ61YtkVFCvZxSNzsmZ6WPhF5uVjKXxjKEKJGAwaokxcF
fCtoCYyVAC5jFPFLluJ4OZDAEb/gYsRDE3pqrPfkXVaPKkEYCLVNTqx8TBMLnoqMZ5tf7z6McUyi
lHLC5Kls4AwBPLOJ8VmQ/uwI1czrQOZpjcVOeHq4K6IkXpBbimS+6SzisYIwc6zrolKMOIAMl7dt
6Nhi2+jFqg9ZEEv76yyn2+RQaWL698J6r1LqdpKhljX4y+qW59GJKEPMlic1BuflPGUo8tGboFlK
trTwsSWKTuNLPowM8Mu5mhWBRKbYzSGtUN+YPDvQ+IvSl5VEkRvpdv3uRDY10lTGkD5QzcsbEoNY
foqoC1/znFm938MoYvlxPZSO3UjKTD8ny8MC2osAUKsRd9RtReI7AziAI6iwVdDuYVjyF2DB2yli
ikj7SmhiM+mWBshY6ASgMWsiKmdiWso6Pk3Rra3a9KMZF+Mm08s6OjgFCE4WLI14WEVQqP1kMFch
q6oBE3QCwKBhrHQU2xHTtScjLbDpDwj6yoBRp7PVZ0Y9KjOm6qmpIjFsG7dAls4yxbTZAkoI4GP2
rOW6LnS10zyUS/6y6HF8mDtKJRDLsaHvtMrMOZwyBRD7bMDnN5qT6+wiq4ucXVIaLhlkIPA/sby1
CGJIYjQQv6KJQG6TOS6aRBngYTrNDQAG7JU91rBFxNPawy7rd5chrE7LV5ij78BclwdC2kLrvmpd
c0Jw3Q/G9SQW13kIidRKfMy/bGqwnOhtQX+uN9JGgLFNklDdigQ3DxbwYdo3VA8tCzlerY2Hqo0r
0tH6lFW/qOuMud+l1yIAIgU371/NOdUILk2VNshdzCrBz4yGBwRPaVnQyAlzqD4JvWU3rZvwOMRa
Fp9FuWU8GOPs5Ufa9hjAaNd37ylCrQLzRR3qN66eW4HsIftsESNFDRowIyGcqqqfOpvwuCAqULPt
DBlh95hdSFgIXNPV4uHlDM8ypW5TVuV3xN9JzEU0LWe/AriJQI2KmEinqX+UkR6+28biTYeQWxpE
aV69pRwUl11NjMcn8HtUfg3fzNyvFAIsPAtl3m9rzMXkYIKSb/fjGEsdtQd7F0YMu1v8AWdnvxnH
ejqTHHmYBhvLMB40rYHL03EE5kwM0etSZPB6HuD1hsxutamWu64vnbsuTXK1c6yEdSxzzJaf173s
QS7z2LL9eMv5UKYAOqEBFcdMcCTgi9dz17pCIWstbee8CoFJ+rqL42EXLhamSQIF8Pq5k0D7rCVd
Apu36ublBjdfBXUQynm2HeLJyrdNms/M2R2PIF0DkuLH1Kja3cxxJax9MqWy4TlvaeovukTc2bk8
B56q7gyiiBR6tL59GKo5W6gYbYu8u7VDRDZWFPuKjK0I0Vg3aYFF66zYLF491TueFL5ByuTIl5O8
NZwzzqnfIFxhPTAmfbCvNIbKRGoSoHsJFZ9aM1qMatoWhRFH50VX9ETLEB75Soqt/VmznBB8OpIY
elbMg7jGDceAB/dzlzpnWgEYfptU9ZSc3BjW5zbNWazPAWNU1co4TaqA/SC2AjEaYOf50i8uwjlC
M7yORetCYwZ/MZFXZEEwjm3nziqVhuMnguZ5cgtu0nY9SiMjidwh900dZdlOJI19TpW8zITT6hY6
nKR0nzU1RTqLExKITQEZxj1EKo2wAM/xolFuQAMKZg15L2mDjGu8yyjkHLElZWRxyT1N6+UqtR1S
ylwz7F3w/063HCjQw7bfEkGA8R/2g7FNBOqGAMFkpW0HoieoZHTcKs8VEhJ7lw1lbbBtaZq5bYXV
XcCU1vITqQjx26L3gjZwX8fvocO99rHX9N15aaCTPYPhnzlXMI+c4Wdrh8MQpOj4h2ORLNaNlsSW
vaeialn1UbhNYOjRfuQBpY33YkRWcSAYTXc3/BYLk1ML9eY6biOXEcQgCj2QNC3yINE07G2WTdDp
eWwpL7nNSGXUdw6r13Ac3UxF9xI35uqHrEwVxGmik1S6oCe5yOvJyXbYQ9T4bAyq4jjezm5UIIKG
/SOzKBz2DPFKdZvBx8YfQDqB0TP0cdp55zh5SGqtmjKyGjiF47tEi2lQ9deoVFDya+M1gNaGxhbJ
szeqI0l7JwHejb45Mrs6VyP90icrssob1I+Y3YkWKLCk6nH+rM8q9to/dLp+7SFR6aNjMVzpmB4Y
ja8dlELFZCxwptojVSsvoUC8Vjj4iOWecN1X8fQnOu/aOPt6LHaZEwASIUaHJ46gnC8dG4/DdzbO
c79P5nR4bM049tkJkluipPod04qw971ifAY0019Q7/7JOP7vXp4GAHQxWkd0Kr993N516DA3TCX0
eES+1JcajIvWspqH0YraR89o1c+sK1FOlXF7rpnaz9+3R76//jqxoT+CmhuGCv3ZtXvyt4YV7dO5
WXOF97RrSmImHY0uDPXYEflTF4DxqIPFLYdVjYeontqy3v7+DXxvS9CNFsxnKHYMutLC+nYBKqoJ
Hcr7DC8MOTmaa3XS4kp/8vjo567TDy82e/EfOu+/sBPWV6UVBC/MYVxJmf/1Yyu8eaIJI1jzWvrI
xCY+DWPRETsct/FWX+NVVeK6Z4kBXSND930LWyL/Q//nl0sPBs/+i54Aw1iY3vrvf7v0rjviFubO
7CPK0PJkO1DdznRiEUcfAmK9nNWgo4rbqLaaj9xT+hVMla7d/f7y/9U4/vvzT1EF1QR2AXNYotT0
b1eCToiJzStLDtXcOJy3m2pcPhq7HodbBCtC+g2NFHu1x3U/BTV4vMvgNHUXXdIa2UVmjUK7Tguv
bH+OXZXh/41JJzpTlkyXA5v/PJBo0wF/GaolC8KwIsddESxysNds8CDVmrkP0hpBDCGfRqafLRPh
Ngh1onLcVZbuhIcEjlX+gPPCKp+RiLvi0k16PBd2FPbqQPe3gnnhQKY6ZLIfLUKd6H/s+tKzMtzj
mA03k2YV+ohX2C6fGLnPRtD3Iv/ANap3m7FBOOhXMMPuabwbHHQApmRngpzlbtdM8TLvf3/JfxlM
SoPBMgQZ2wSOY0vz2yXXEdHOMh2xlsF13k4oY3Zh6S5buxbxY4IQ5NzOyunUl3m5Kamur8DJ2/u0
Wmfn/Rz7pV6Vhz+8p1+eAwZhDOBc0JeSLhvot69PY7dUhdIA0e281gX0NGI1005dkRjaYzfngAHc
cMAaiY6y9pXpLUXQSyojwo0GwqSzAljoI7nmuKiRtc36HvWOUW+sgabHB+bq9tHFN68OZM87UTAW
Wv0iyXlA7TlN9nPV265D7SrrJ61tsuQ0JSiAM0i59U7lpHgfyMnL9E1fC1CwkygQZwDKQPGShzO1
oaLtR/IxGTD+2KeDPMOvMRYnuh+2dTOayVTtMgu87J3bOao+UnZ2OkOcMrJ2ON1HbdNpiXueAkC0
tkxS7SdRL02G0LeeGprlfVi8VCRSh1dzZ/WcdCF4NLsyoX1CkgxsAJzbtJ58o+tsNBeG6JLrmUJV
njj+MPCGPL0kwUw4TX9F4lhBB7Gom1srQauPjcEY5qMDCch57IkgeiV61UQ8hT7DITPIEI/jUJpv
rWb31Vk70X4JIjJUIySwIox2xcJ4BYV0iy43EuWy7DLkZfHl2DUjB+R2ce+twSKNPa3Uctvy9Sr8
EoqIs02oDaJdHmp01aSdjzHnud7DRJzgU0DMwDCMOaE3XJLo7pVbOA10zAFENgF3YQm3mAzndNfa
bv9WZcoiqAPmymkyFKLYPkraXT/NieNTxfERoj5yUDARpQZLwrPajRfmhha0cOXjqyExhTiVes5j
biMoGnypqnJ8B3iKen/DAwCcGdxqB5uHQZhmnqvGW8+vRqvxWsrJ9uhX3fm6Slu92sTkfD9zJKMQ
RvqCEq5NRTRdqdarnVujL7MTYiYD5bjrZBG+nbjfI3oqjV1opCraF9pk2GdYAfnQpFJH8SVEg/AZ
rzsQdC8lBBwmAziqvDHCTyvqMERl84hgbATbeGqzSbanWWuQMmlOMT7madvLDZ1gvf/DLva9VIJw
SN1rr+k3a3qK+W3ICfKcrKp4UeC1oOOpyWtuloaYF8qZ5VjwoP2Hc9z19agTVqoX98OQ3zYsitG+
HwSvZ+aaeQfA+B2Qz5pCrKIfkd2MP36/Jv0yxOX1HCJ9PJIj0C0AYf26JJFVXREwl2GHkzbGGdlM
V5Hydg1GyJckBy0D1WrIznpvKDdePFrGpvPEtGfW7r4IR72lUi84IDsWc1wJYxZ4dOL6RTjG4dZD
KedTD5Xkaw/FeYQvGsNpbD39/jN8H7uvH4FPIITL6MVwv0eGcj4Loz4Fu6cmuC+4DcjTxhi1deRC
z1UJiGg6bcDzHlvCH7YZsc49/76zo8chmYHYIyb/HjC2b9PYkvA2M+lJhi5iLDfIF1MIuS3xh/M+
1O3eu+TMJe5ipxXLrnUUUg9tTJbnqavtfis6KOA+NSNkp5YjNkY9sxcHzphYG8BvLe9O5oSv7PNO
d4eaFfs17h4v2rl2j5RZ1YZ2UcXSg5pD92n4Dw8JfDSXK4tmhAXIML8XLQRSE/RcDoSntXOydej2
/FQJOFfDwGeKDl1L/lClmusw7uvFBDQIwx4NGvUiFfPXZ1GBGoQ+pOr9OOv0vENF2ozb50DqMF6y
DVjNGJ9JmhH5XqjGEZukKA1zi//H7AO9W2PdrFLHXgKcw2Oq4zT5Y9FmVof+IMYywGkMG7KMTCxG
C6PqRy3vpwcl6lgdERLRqo/LiHy4sNUPmPlyTqxW0h1TFBzvFWfDYFxnx6y97eNfT/B/FEh2VX0W
d13z+dldvFX/Z/3R95JyEEtO93+//rH915/VZ7nmn375A+MAxkc3/Wcz3362fcaP/iuKaf0//3//
8b8+//ot93P1+c9/vJd90a2/TZFb/iU3bKWQ/b9InfX3/+/PXb7l/Nymb9K4ePuv3Vtb/vJj/4ob
E//NgZCFx5UeoxOCl1h7x8+2++c/NJsgMpOVwV3Z4BzZ1krpf/PGDFJcmTSz5XNuxb24MgJbkI/R
P//h/bdlEOmLFAUK93rmkv9J3hiL+9fTgzT5ZTT7VkkXrPJV4/b1gUTMmxuUQz7C8YzCY6iXS5MR
4men4XUdMvg3ZFlgDSw89JVDyuBDQWUZogOOT90nIsYT4EeMIALl48mEabwW9YgPtJ7epCfPMEfM
TKJTAhNna+fMOEmrDNFQCfpm04WNvmW7L+niPzRNd5rHumLgQ3IlQYb1oW8RA5C8cRdpy54OwgCp
QIVXkEAbOofODv3CpplDdVEBYwpcoxqvGG/0fulpSOc1kFXcw+4WZ7zaVnN4M8/zU1gM2wR1ZEeD
MY/CceeQhPNEFmzhG7I4nw3YfPTdVtGOI57zqY321ZJXvqipFJbWnPzQqQcA9u1DPiT21dgJBLEc
LTbSyX/mWDaDsB7ba91Jlp+2Fr9CSsdWtRj4rPAJHkVstgE4jvAqwaZ/RvBUesME3zjmkYkW3GuH
Bxxi+FDgHBsnG7fKgraJCQ/0IM1HoXNTxSMh2M4rECTjY0qwd29aZibjtjAq/WaeikFt8aVjPhFo
tXhVC7QCNcUFEqeiDEYmM1TDofuzjqCWRZHZp8BjJKJZr8rVS+kyQtxQN7bXKhXyKatDxB89B5hr
hiI5UOzV0tbk1byxlTSPVG5jfU1FWFzEjfzpQTIAacQlHALRjfNxRlGwn+YCxe2m7bwo3jt43TG+
k66xOgWGGB1VAQXG7BODg5/KvWeRWO70A19aiCGu1q+qHBwP1PlMGPcAA/TLoQGE4mhWkC8GM0Jo
qCki8ASiW0eQMNeuTs/LGBsvupai2zQZprQJK/DV4HE3SDqoYAbGQKKa6tJiZg2Jkkboyk+j3Krz
+bQo+SjHQqSnWFjFvjSsw1Ci+GAjg1tUiFdAKFua1ViXpiV+wuGhtkuJuyEx1abScYotTMxDIY8u
UZBXHIqjE4iSQPG/QJDmwI5TpC8usZ6dW6l+nqR/+YsBicyrgehCLXmgXMKaeuGiQSBQNVJBn6cD
aQ1kwsNKi2aDaOOK8hNPctTgZh3s+kLK9MockGXmAFZStMt5ey8TBRVMZHumMhighumSuCMfmH9n
3g7lHVaofTXMJAczcYAQOGMMyPRnHSPpbZ/2V+EQMpmq9yxHPWfNaKOH4ixrLLA3ZIWZ4EjAN2xY
6AEaCNhB+RB4i8uYEip/pjO4ajDcYC0/c+OqOHKrdgjLzzJ4TQT1iD2+WcOnxjfYzcxjEkfouyx7
ucZjhAQ+SVEO5AivwRpUd3xtzg0ORYpzJNr91H2I9MI3MebNbuzT6j6ayF85VR4ZO10Jt/SrVPpz
s5yRig3U66fFqiInIzrSoZsexsZ0NkbOnDCp91YpSXENocFF8kFmIVGsbW6zzrWvISlq5xFNCH9K
459lll1nSdVulgRfYK/Xz1U9fmCSRybIt/EorP5smvJtP2WXRd2+ZeRUG4BQDp1p/JiLdFIXdOdN
Whxtv5+ZymY30Nuwp2ol0nR9Kf3Rq/dSn2OkjaK67FAecn5nB2+LpWH0SnjJNhnS6AxA8qzBXqDx
yhFvMDfUujtVpwg/GPzruPLa7I4e+mes6T+KmUtlRG56ky/oz4c0wIq2BAXoLiIZe+3WmsP2w1ya
W13Tw9smD2NBaaldcoQhVzHMiBPbYOIYLmyA31tRac1hrEqJXqPPjkpVBm1G0W7KvC2fNVB4voB0
FjBe9m6LJGljuBbLW9q0HjbkGIa56HzZiSVoqpYiqETlzyHlAoHTXRQCa7Rj9znTXCzCWTIdR28g
J2rQz5s4iU+RWXknFwURdLykOg8F0/8o8wLkGEx+83sjG6/JtdiioE/xiEPIw8qUXIXYPhMtepAz
34xS755qwumt9C2GA2tH6k7GCNZkqX+6sYNgOTwV7arRWEN0Y3YV05kIi8QRp6X1O23IC3zz7znz
Cg6nDDHSMr0BjvJeawh38PHBSDBIKuvT6lQmZBOHE1apZbGqoE6JPciz1WsXAWr25sJFAIQogNp4
9KOwMDf5Ur0j/oP51RWnSfeSDw7b7h5SxQcNhxMcEH0nVernTJWqHPdUoTOfD/PLOY+v6lqPNkkz
S8CYEVZKDGd1tQUuCrzk0Zgel+WltXEHwjuPuMoNSbjrw9bK8gky6HnWsJt1VhJ0/XSwtRf0BsBp
wcM4YnmSbrpPtBenaQ99PV5Ia7qn4YOlsKmLLU/HZmFQV9py3+vFDViinVVOR/xmfA2E41tyuEZ5
cUVnHik0dPU4KX5IGaFWcdsLsejHvm2QG1nbucgAslkPYR09h5Z2Gob+lPLwlhFO0i45I0zb70m7
8k2lv4bIxxywM8R4+7m8WGT/BC/7JDTzXkMRu5GNdkncy+cy3NWtjHbGEKabERv8Zpitn05oBzAn
96F4s/p06yaagf0BeBKGI8u0n+f2J+aPw5CrC0ZKNHwKVmA9uSyx11ZhQ8K6G18nkE1FH12jNbB8
gAhItWhfzQlR3LLtdq4bXUTm2WiG+LCyd0AcR1WhN2orpm8VJAsD6LM17jxA9K6LsId5YDTZZgAv
5sJjNlPnmnZ09faYkVuqhbjLjBk/c4bW+yma1Jk5P0FP2rsMS6cJk6xgOpPoI9wtwUgsVsPtUHuH
YZluhmgo/IVOVx96H3xZgcCZexxEaqPLcD7aNY7BeNQ+nKo6Rp6344L5PBpoRqNjmc9sgdhdGwIb
QBPozr2tNW8NpmEz0bboEi6VHtd88ZrLUIfNVXS3AhqYhPVPs+44D6R8QDEMrXprEEZIE9LwRZJe
uK1kAJrlL2n76WbO5VS0z8JA613PByu1d3YFMzGiFZWBeNXxh3bJUcnBJU5eR0wTNR5J8ya3V3do
rvRQ9yKWKOucoc35rHuADgx1g5f2AYKABhb6ZWFwzeG/PJhDLs+mVkv4oN586vIPbuUxFVyTMsdn
n1/w1UKdmmxRS52cNqRZN6SXSDnBNuGwdwa8unSME6SP9gWpAICfYxngGrlVTPq4E+1tTYExdMO1
xtx3mQzEYuMR2ybNQ4QAYmz3wDC2Dlbd0WzvJgIgt2U3AkdC0LBtEY9tGd0PBxCizx7JVvdDYRWB
abfemafx+EET10kI1uz72YyfDfAhy3TZVeZdWU5bQPq7XutuYFacOUKcS+zhYyuoNGFjWajNO46g
dDNv0J7cuvGACTd+HQkS6PocIce5GDX8eshe43DTc+0z1EhAIe+x1A7kf3Uf60K+yzFbs3IO+wyC
oN90D3UhjrAlNmtNuksr6W10dmsvAqXskt/i5Fs5dDs5P8Fw3Ejdymgv2Ezr3BPp2hu3jg9DDyUQ
jyExxLbNo165W9RmgeaJd9X8KIgm31OiRzxKFrGuon8szPzFmN1XkU3hyZZZQEOFJYC2Mq7VJ7Mo
ArTFRzqF3LeUvYJ1YViKFfAh2DFikLNIIN86G9XokF1i5QeqBVOtiH0zx8NvkjeWOpspv8jN8NJS
l2H8WpQUItZVlgKKKLSj3dYvLcEF5EX6tah8IkJfTZXtUvLMO4b9SOiCFPMAdng0m6iYkQPvytzd
Yn9PUdtnb7WD0Rf+CsK3G0xc93KkBRdXfuXEe2HZh4mwQSU8Hp6x8vNK0AHWwn1csmskVlAT3h6k
pQz3HfnutRXeyvoVTvGMAquQu8W6NcEE/yVhxCMEjkaaGzgyJDvZBvZomCVSnnOw20FOxjrTo3XL
0sd66LbxLA+Qni7RKLq+lv1gquZbxlsrrevZkj8M9Z7pzrR3IobndXLqjSezFASmLDwz5j2qRjrE
JMrTEgk3CTAaCsq23pRFbb4iBwpfXIV5Ant8At1oFGiZGw6QsShLuKbNXTPJ8DEqw2T9OzVf4N+0
d11cUTs4XUmakmLDbEGUCou6ylT2wjKxysjTH2SZPo+szxuFTH6jtPWRZGDUqvhazOaPfKLrPa1c
rknuynJcTlBOaNvjL7Gt5gka+key7qVheq5p4F2Mcd8s8Y09d3oARuWSqMWPttZOTZxDqS6cjZ3i
zg6bjxqFxswj5E0uOSLiMrOsoMUqTuJJKTe6Xu7Z+QMgqWtASnudeBzzhKGlF8VQJyvZwjvMrQ1K
Cmyl9z/snceO5EqapV9l0HteUBnFojd0uo4ID5UhckNkiKRWRjOqp5/P61bNTF2gulHLBga1upUy
MpzG385/znfy7VgVOrQiMM7yjhuusRub0DlqTKNPlQJ6Bacue1OeX/5MjJXsbrMi2rv2cONVjPOg
B9efYId7cAijsaXkIbgdVyM8sFkEsWQB3xiiIZnoKiONeOPYQTXFjqExL7EVqLEj0af2e+wwx0R+
AXmjpKznkgoJgkSsAWyHpu09PC6DTnumHpnlsaXJ9GOQtPFWtsy3+AKb0mCddiC8rsHvqTIVLwCg
sS0GOFXkHve4cZt4ab7nk4ZLrVmht+UFcweLj/G+m2A2RgtH7ibTSX4X5s7EpdtQRwW9OBqHsWki
+MHWKbCBc24UbogeTGeZq6jDb03oX6Ag4stK2+2I7IG0wWDxqjlHc75vNldQtzK8w+oE4wCaN5nm
TbUOLAuSsJkzVDF3gZhauR7OfoaNyeLwZjhVB4/IpHvn9x221Lnw8uM6GBlpqHRhUyV9eQ51FT7D
eh4eB8czaEDy25Usf5/yiS5rFyMX0B//LlGDsck9eNxRxQ8eNFNvNMqsudXpyhevg7Kj4sCploAg
KzLrJbAM4e1kOazrs3DzvIzxvRncHMMww/do5ce655oWu0ayvPQNZStYqXiWZLlcx850oQXR7IZz
upq8wPC7+j30pNA3LGgARWkegbcWHYA+X8jSORRrSbFhdKWcdbfG6DSpFWOenGaAf9SlAKyfTZxB
EofXxixWi+x4D+pC3gGY66djtfre/FRoUVnfXNwy/xv/LMfPNDTuKROJN7/V+TrdKOWuB8z0tb6W
z7PHlkF+sNfWsx57FmfJhpPAOieWE3Iy5QRJ9o0qqmQvVCDhBbpM1pTIYvfCmtkEt9CYgi7ylK0F
jp+5IHTO/8VIEKZ1GhWux/fCW4vh1qONCDt4SfEHVL9SfLTsMNJNo0KlT8kMlGqHZyk5SuFkJDwB
BIp9nSbMeosShRW12vQv3RyIDjHZMh69oXK+iY3oD5sWy4fFmodvUmFeTCGJiBVOSrDYy3DqzLFl
M4ilNppLYa/HCeSmfQ0v+KytKujDjYCysW/sleLIvOhOWDPTBxBiSRaT8iPKQ4OxhPc328eGbM9G
EJp4y6tiOGNxQk3FJbZ1zclfooxjYCTLk3B/KFM6Qr0kPIqxDJ86JYLHPg/aW1tp8WC6FoCGEhTg
SRL3lFuvFuGrwkj2QJTdvl63C0CNlRjI33v9sCBoLMVy8mpI3Xz3pwIhJBfhPfcmAbW1KI6DRa94
n/mtG4mk9N3dTErtdRaZ+m3KgM/6lMCczZ2seSIV4lwAAQAeAQJ6rt2U+4J1k5sZapfP9iyqra4+
eiv9Hnw+oIOAMk3tp5Lj8o1VRkcsqU2fEiWZR9xpIEysR1Q2wTB+V2PFeBs08JyozsGQxrhn01+0
Tmf7seZOXEAp/Cz9yq0iNVr1C5t8gbyI3Tgquqy9Wx1Lfltpc+FzBIdAdcVvFr8WH9RphShHKQmv
GP6dPcgz+Z1ZmYijDefLFbHX6ceirxHZnSF132FnQwzF2+oFN4pF4isOW6aZFGo1VGCodbq2uL6t
rq06Pl4+ekUvZgzEcHqmH2ithGhhgY4H65o+BnvKkOxeHA/qrlU57r4zAU1EjtYVa9RhOCC/OUcx
p+JeWmziI+DdR2f9mcnHSabUJAaOeYPiufg+nOYRi37PU3hyvNXZ5b5qiYakLeMzdRPfIPcZcUjI
0zkOIuo+xcr+NDnwBcE6DmRj8uF5NjPQPEjPwy7VYr6tdOpybe0eV4IHdxZ9FjxcDobCkfsV/97q
weGEuVrsm+00PzslyoCNtHCowt6mXqo1NmkmqE2QSJF8L8z5XDoWuktAd3nlkHPpHRC03tSYm1Ek
KKnqTkPqMStep6LY81hVsSnLtx60usTLMbV7Yw7Pc51+NS4csspl7QOfdaiOdbgcdIg7304YO9hf
mXgTbqZgSAi4FNYGH4nNh5NqHJDNOHFbOd667ZScXLkILj+l8+XVyngtUierdya9Ai8lu8aJiixc
mEmv8jdvKM5L0MuPeQW3VS+z85sU0gRxxjXHc9/Z5VvVLst3RVXaO6Z195QsRozrUG5lQ5yJp2jx
5WHMgi48qsoYCmbCspn3fD7r7Djio3ir/Kb4cpTILmW5Op/QtVnf9b6RbynCrH6YpH3fvTbs7pyB
QPmGsIjxK5W9r2PfmI9ZVupna7WIdAVGOF4WO11x8KkEud1U3kch3fJkk8LZ8ZP2WkzmwZxdDzxT
BfqSCcnaTnY5/pLKRZ6YVH9xmqo+BL0w97g6fe5c/sqq3ITg0TzMM7qQTs7L4q4RaTZ7M2Zz9oZF
w9pPWW1vgCo2m7q94I7F39zlHphqckQJBsKjmVzDYMOpN9c04kVeg9W8PpJzrnbZ2t+OUz2gOWPe
Tcf0jJxVbAJKZSA6WNYGQyTlPtirX6Z13s6Nc+hsI/tSPuB4tx3O7HRLaiK0OrQJi2AcGy4dx/6N
H16JUQJkP33Mm1YN42Fg48WsQE4YIRRrC31NbfLDs+nfJlFeYBetTazRijaIdlnv/aF9n3P5XYz4
cGtg9SAEuWQ1zUkjwRMjm6kDsdLTqOoXowJNA0zul7+Aqeuywth5+Pl1r/dp0CTHLigQYibvh0VS
/06OiX/RTYHSYuAzQcvCE6sY6QIY9gi78uJ14mmc0o4EygpcdPCTDztoziwh4gnrNjtl4x1W43qg
Qy9yAZzuQugXG4OtkAJzvg3Gr4LUUMNF69A1Ay0gCoBj6mHYgdTH+qj2gbyOr3NaSp5jcYdoU7ww
fpYgP8dxy/G+T3KCdDNpBX6b5TFwqFkv2l1a0ao3Yp3YutCID60ziqMZeNYxROQ9LI0c3xe7qhmt
JWKFkxr3lXgTAZgVLU8pku52uV5uQH48WGWodmNanPVCWlet5DGioFyv7afK38x1SSFWFTD/uvYF
aAPycA5dsuRZagPJ661hy55vgukzWCeB4GHuuF6TIbHdMVrQCycSkI9VprbK9OutnWKNNqx+yxbm
5xK0CyobDFWh1atbIpn3IQ7vyWaH5hJaNQLJx4M5bKNA0W7MxOcJtObjMKtD5aI5FlkuHybqpJls
5ztWCRQbBF6xq2pd3dSy7J7CxLwlyGAdtVE/D9ZyY6fz1zz7p77rzwFh4aIrXsK/SX2TemKCN6Oa
6lzw9/78lSLc2UUm74aRMssih23nmSVNfLPUB85dvRVVVZ2DGtIKTWPLhtTb+uDZ5YfSfh8lPGkZ
W8U4DF2TGH6Zss9JcbRkP1zEe5N0ALo99vlOH+E1bNahfGA1yPrfP2QZdrkxmHk7TYxfDkz2QW4H
Q18aobYAQt8UETfYKVC55dI8FEMvfrXzGDxSa4SfPuGkY1oyq3OoUsYKvPzPMzeBDUH6YTutbiQ9
EhwwExDc2K7sR1WpGxLbJxsRbzPSODbgKXoJwzK7JMawE7bKHy1Cmltc/DSCddRGYqlaoywMfvU9
68QN7Gz7dpooCNkMY3I0WxdBzIpVZf5c1t46NFYaURFiIwRO+8kBDtFq51lzlMRzigVMN7X6IFvo
M4zCrRS6eYRitjGb9SawvEdjsD7wLO8rjkRqxTd8R08OwTA7fKKy7ajSHLLfBFQtMc5p6R4xhh+p
yfjZLdMGjtGZshzFIA5c1gWMvx0g5oZdVyGpc7CH1VyijZufztjEXcVXUxT9l+U4j50sz62TX6qM
/FtBjxTSPuEQ8ogHjwj4brSpKEB8HDPb+aHr8KQR8poSApOGaoUsyIMwZ1jz8GkNr3NtYMRk2xJk
MNLktNiUFa3i7EuwMWl2dun9AXUZkl4kPQ1oFJLtlvcy2X5zevMH/3Wo2yeus9UPvpw6GiDWb7rg
OHWkaq59nDNkYV2kN444TVl3LhCQ7idt5jvs+5cC9EZ1rZ8uBnSZHlOf3zSbmQvhez7a84eUs7iQ
ulRflDhqb0sh0xzPs74q6XmPo8LgESRwbyCSRoAWw4e6SSCpQi8LX1KuIMaZzbhxcZageW9TIX6Z
V80Nw/7k8ZOuz1PQmRI0cW3JYQvLoo+72qhqcLmLYoSh8V2zRbH2wp5QnZNhvMDECeKgy0CTel65
QoZmEeVW5vpJmMdGg/MowgE+xP4QMrTyK80BRs4Qe6zD0hIx+BsLPV24yTZX7bSndMreEFcq3h0N
2Oo2cR3omwOlqyTHmtnaVC1GnH/f3nGbf8oWkLf6Zy/H3/wZ/9fo8T/OBHK1RPxrEwhWkPwjhzXx
p6Pk+PWf/4EjnP/8dXV52OIPOCm4LCwOwNDyQ2zpf/o/LOsPhnUMQBiBKOg2XVx3f7d/GJb3R+i5
JlWOTuBB+vEIE/zd/2HYAT8WAhMTwCoAjGFR+YcB5v5PoxHemT8NMX//7/9FB9N9C9F0+M//uFqE
//xZ179oQGj7+j+cZVAvsCT91YpHzxewWlux2cFg+8Bb5+dALJngamD/NwZx7y/oEf4suCMhPnUH
mjVefe8vTpOhl9YCyb2PQOQFkaGnfjeZ/NFFVc8UvjRsW7jCEeriiu+BtaiybefN05NfJ82vTjnN
HXVDcPJ0Vh+DWpSHEXM42Vs2ElVmf4cGVQNdN7/mIDpPgx6M+1zbHIUMwfdllXDXWtLgCRDpXWYZ
NHzNItwOYvxeJL6/qUmdz9xgEgyS9C0hzkGBKBGayHMZECKVJwtDDclvjKijN16GWt2TsFffiZMw
2wCf+QhENuypAQY6NBhDROfaqRoXZ0N6a2w363XrIbWkFbfRzdcSoJd7Du/EepSdEy/XbgCmbmxo
HaUV2VYzv3DPqVX6vablCuSXnf2OU5Zp0BH0+NDbwNgjFZNnaJQEmmoChuZTmHlOZgWHts6ZVGNW
EtRWnMzwmmPfMUsu/nTyZ0Cqb8xPsgDJUaQjEUXs5RcJ2/SeaLD+pKDI13yPajcHy91gG557a95C
9nYZwzhxcaFdKxfbQRnvIV7sh7VO2i8a9XiFQkEONlC8CRqP1jBe2w8W8VOtvRceiXQKCnBIkLaR
NVG7cRJYgd8WnBN0ehMVZUU5mZjW2WukO0vi2wedO/wATGaxsZNe7p24XfYl2yOzWCj2kuuVsqsg
ECywUl5t7ELqZAzlQpSsGvm4ERzz6eXBcXElC4RliRtEa0qt6isJLuQPbq9lpH0fKSr02l3Xp9nJ
10imUNOLZKIqVjYwvVrKjPka1HNhiimMKG4ZKM8wtfc7oH5toWkHsiirSRK/BBozp4kSt54GyPIg
OyOXoiY3chYzu6aIfed1KEbctih0ZKJ13RjfY0JUKZJ5ZX/RYobhKfQH9BYQ1VzsIS43kVNkobEZ
maDGiAhoeFqxoBIhJPNIIxciPlRL6qeouqIK6LOorepCX3EPIWEICBb6kw+kUU4tdWnOqPqvtfQs
9lLUxrWs6f3eQyKtqIezpduPu1FSTQMfDw8P5wKH0tIN36WElQl9LpveuWLZ6Ja0h5w6u6KAyvGy
sGcKxIO+yYzqOgODaqF7UVAbc/CVqn959B9ynctkFVcOGd7dYo3842A4M7lQlnCoyQegFWN5ziG7
SF7GD44ogk8+E7l77IaEbLpVjSWniA+LngNjXj5kdi0wVHZpVzvg8JKKVSDWMA6kxz5xNY0n0rxl
EE9Afy4wfTAi5YNTBRtil6u9D1s+MyAg0+mhHomdRHlOBjpSrMGvN3FHvdDHrH9Ad8XNo9pSQZuW
ASrE4BsLo88k8gPNjG3GDs4cvhuPskT26bne0tmtl4OCHoebtHVFv8W/bRf35jhPX74zyHmTtVSP
QTDnOh9l1Bfdp1afv5kzmZQ3pwidr9kS+tMiXfZI0Kh24pZmKnaoxkgkvmNha2HoqVFVejRJY6YV
JKtWuy62/eIN9wkpHC9Cvct6TGRoqwdgyvLxyncDdGhhCI/KsEt/lw6tMtuiBuZ7wq5DmFQnOEy2
UlUOS7h6bvUFx9LK81LPNIuNTUI9YAD+Ktsh9st2a0/Qp7EujL59CrEid8feQSFCaM8dSAZKtCx8
i8J+01VgO5vJDsd9OruLuTF6WJ/sdVwzvVn6hcuXH04LRdaNqeZotc3eeLZhUX+qkosThA/w+8id
4QgkplZUfaXO9Ma+zK4OVinHIAJllZSb3DZQBqa6HoLXgVkWuR2VDTZ1yzmQ8ZeFLWRW4wutnZW9
SU3ynLdVCFLpZ4s8pr4DaTX1735sVjjU8HvruLT7XnBds6xJPoYFiPqHoRUG4HtbNKxZIAUEjtgu
4Manp9AAv3230ElEd9RED1nKozLYhUKzyWCO4n1ygDNE/dAazl7LpZgu/DtbxrEODCjMkemNEG0c
fv/kkBEv02d6P12+pBkuyuhHGM4S53dhlF2NsYjBESo1wUJ2MWj19By2PTXQTVRQ3ZdvakNbax+n
ykg4kUy/H35MobkgWSC31cGLvzC6czinRf/YoUBRJ7rY9npoFtG6+2Rw2KZOTj9ylLCq5PDryzo/
pbnVkcCqSOPdGwjwPSBVu+UdyotWv9VWVrZ7KjVdNulIxdYmTXKXJ6r3zXDjtYVG7q4bBK/HcuDp
ODSl1D4Y4ZoQBVJyaaFbTVYfvi7whkwMzqGgcKJrZV98rqOy1XNH2Na+XUCw17dCdFaP3c0liMgz
2frZTTfwDd0nI7GLH5TXrGNMg+iY7W2y0DV/+0GyjjXq6TJNi+Ntodjk2S3n7zR9K1wF14V/WgsQ
DqZzM2ecr3S0EWiLhzJzbP6FvLl5pCzBUKcsS7zPznJJdhhtWFD6MVQNzXXrkOl7dAf7Q1hTqn9L
svzZL9e1an3r6qpPb7A9+faxNGl2ZocPIjfbTByjps+ma+k9uOJchcdtJ6+q4iZzU+pi2UF8zYJ2
xnnmDhzSqXrnGYRVIqaUGgzGcq3eqcNVHEAoZIgINbpm3C4YLW1nqKJkLpg42PEeBO6dwvaa96ns
e3S0a8Q6X6t8mybwwZkZ5t+Cxi9uxBxb0PW5JhOBW3mSA9R+OTcXCaJ9Z+MgZkc9Cs5co2OtOU79
0fXI08wmTvQm6UXsq6U7jpTovjQlvXqRJsYZ0xZAfGJQZbQIRS6f+I9x21hzQEPA3EReHk4xO8q7
IDCjpvP9g9M5041lDdNuHPwvulbGQ6aUt/G5QcKeTrod3Uh07qn5a8X1sPdsVnI6KTEYQRh/7Yu5
uQ+hoWwKP7MOkmThGxV8yTuVftTV8rXi/h2DBir7UNnXRtmVtvbIXhgyjYr4cOr7/c4rxMFl2bC9
phaWeIDEzwcaqZ3iblJEceKG1Q4mmPEZJt4HH5PhfnYtY+MoNBMUU30ruZlxK8UawmlVyW3m6PV+
Aa0cc/J1p55Y9Z7yAeMzdd2bIJtV3BtlHderY1wSD05/1/flqfAX+TR6uqW0DQOfySkmi30wZL8p
B9Qx01zLe7IBZ5KGucBHyL0UqtJLKaskmmaDLPcwmRDpST/5rusfexqMoyJr6ieMK8ttApDjVqlC
HptKMPzUbK4KKsN2mRnCU/AYn2BidSdchgC2QcnCnsfweWMp+2lWYbq12qxjHZ9RFWAj7TKA928y
707SVM8lhjw2je7wUWlc8mj2k3KYCcEOsmh7LEnS3w2iFHfuWMHBGvEDMAfHRsdSCGpJq/d+bi4v
VTKv/S4L3Z+CgRYsnDcfm8ZhDe2alZrooeIRjpUReL+u67R7Z+Yl7oeDuPV4Te47a3rxZ1m/LyOW
Bxr+nBPBK3xxJOG/+tDGXjao9mSvtNQjSTyFgCA32dQw72HokNFaT822wDHvb4bcNaYNhNsf9FQg
Gbhsir6ttvEwBhWe/G0Pdn5sXTuJ2UO2YYxYYEL5LQnJzRgi47AzFOWStlmWPGSF+l7rQAN1GIxt
D3mKF4b1VpTC50ZTiRiWpABSGM44S5wJMwLdK7+LPhvT/3+zJz/yt3u6R/rmX9/st8P0izMn/6er
/fWX/Hm1d+w/gKSEdki2jH0iMLx/XO0d8w/iHtzdwZn4xNeumYt/XO0RBMhv2ddCeeHzWRAEQv7P
1d7/w7F8YZvQAzyS1MQ+/nKV/6+u9oQ4/ulyTy74mg/x6PAO8aKGMFP58f8nGO6ko2N3cwI6wyTb
13XPLjhqrEA4lZa9FCjggQj8bZhiQdW6aC4d3KjzVPRsncwy/DmTXPg0Mok+z5NQ4EIve/uICf4y
asOLFkgCWHYUPQJF9gpgMu7G/CNAbNyJwj01yoSznQRbLrhMDeKZP0vsYQMe7UXutJfoWDeAtWz9
pmV/j4XH28CjyGJ3Bp1lj/WzowHoObN0X2rD67cZ972KEYb2um3C4K33jPAqey5qO/mSObt1HC+q
ap/ma2kXveDMBpGLtP+E3J0hZK8FVWZXPFM9mf1d2vj1hsWLujcEwRbO+Lm2gRpOWGHY6/fpC20I
DcsvY7gGYHu50MM3Zdb45fa9pnNlGPFFXcNNGNC5gl+bRcEqlYzVVMbFi5qs2zaz+hsW7AZfa+WV
46tGigtpsvO9fU5NHRWAXWo2W1tiuqNRTacPGWuB24wJ40rUwymEOADf3EZvrLcdebHn1Qp7fUeH
ut7bCb5WHJRBel08zi92MgKbRy68nSprz5/9wEGzYsvDs58uJq0KpjEc7KlNb/jobCk85Lv4t6Rb
K8OjYcKujuwhOfR46acpiZoij1OdHdyc6E7md7ydet89hwJlpqR1mOZAJcvnHs9IFyWSmVd1uxwe
24NvlWwzjPx1FWF2a6P17yVEYoNRhNthrNhvdpt+yaT1Gkjaa7Dx1zYBFFVnbRr7achr1WhcByv7
v69T/o9TID20wX99Tv38Vf9VgLz+gr+fUs4fWCh4jukgQOGzHVS3PwVI2/7D5GwinsbQCxD4qtf9
45QK/oCTxJ37bz9BcCaR+fzHKWUFf5i+Z1smmQeQH9cT7N85pUTwzwk0grmOIHt81UKJtnEA/uWY
Uri+tIHvmvWrCMNYgKfPTqGNVHEtLG2qiMyC4Prke4b5ZVvd2JLK0s1yN+VWijk1n/zpa3bIbe6L
oEn7U1ibVNZv1JgH34LGjJwGyZp6xjuF39fdAGpOgh95mICNjss0xJ1eFJ7102YurO5rYUDosuAV
mFfCEo29Ce0Tx9BocM8nyYoXC+qHI2OuQKve1np6owCnWXaroZdgF6RVDYAW0kFNzx0FQxJBS82O
F6c0AsozO0vWx0wdA2zJOl2M/iG5OhexW3L5r7dm76XBFu6xZhGZ+U25ByrIVO303EtBnUUtId3b
XI3Z82pY4zkTJoZhSROqC9TmrR8qxrGw4dTVg36Sw8oDmbTvJM8JuaA7VpTWxPZCyyEshWvw2VWx
Nvz+l3/dmsMsWI8JZVKHvJ/kXsxtcWua+mLkbsN3Q9OhjLlnY4XZAN2ImphmnPR5GMomzk3nnQg8
CMDODM5cdf17u6bssXBJnniVjhOz14fmythcMueV9c94hmY70vdtNr9xuqsTGQVnzw3e3HTXsj4q
drjL8gbmtu6rN1HTiEGCWFCrkkw9XEgXizNLmql11UVxvCI7gULv2RkZATrTj9kj1bQr/YFvFOeo
2coH2tXW8B0UVTmcw5I8PwJWA/kyZXCnHjrE6VdL19/YyM3FdfGYjpdizDuiZekZiog9Hbjw9BU+
2Pa+6UHMbmHLdHT2eSWWsVaz4gXZAeaChYCAWdj0zIP2FfSFuP5ceh5ukcKkXYFjD0+Uu2B+5hZa
1Bh2EoliRshG4RJy+RVu42LWxNkShI95Tnht5xmhvh0KxvU5sScK7pqGdNMY9M5Tlkn461ro8X2U
SeByU0K0Pq1F5hT0VfdtfuIbXvo3GDM+2OqZ7tEAk1WeBOF/SF+O/AlFXT+1XiP8XbrAvNtXKT6q
Q0IU5QDC/8FGGYpk1jGZCiWOsLbcl9LF6lNAPblvhINBfGmoISU4AOzIqs9IGQHpeBBvseBl2sfV
lGPpTw2E+5VX2PAJme86JpQZ63Zs23tr8gt019Ff+2iqqNfEz1iiGwfJ0tn3XtYFVPwBGr0+B+sN
LKFHZpy7nqLGPTnmb2fo8IzgkIxs9I9Xg9+ufQOK2LfnbqDlLDaI1Jyogk6aj5SqRtI5ldvBraAk
04vnshH9GbjpIKmKpPGI2hExFZ8j+IBwY2r/zmhpsmKpSTFJy8w0NRu3GTPyh8L9uRQC2ysC+yfY
/2M5Dt0NB5QFSh29GokvQP8Gm9fnw5GssHh1iSRSXNE3uEm1+QG91fEIAIwyhyOyOPMXZwEKkFz9
ivWgkqz4isoFl5gSOcIeO9oTbvjVGQdqInNMI3MyrDF3k0x+jBXFbVFCTLDnMp5QwRbifBZsM0zR
xrwxkvBgkOIttlIapLo6wispk+4N/HrrgYd33l7Jw7e+5+t9l+Zs/9NqfV8QIfK98iZj40PBjjEM
fZFzIoiDw2xDBYJ5zFgakKqZ1h9YrS5GK1ElnG5gKQm6e9EVdkh/ORMLN3Z2YvjnoFDOmde+e3L7
3PgMdC44OFMQv4PwehNUJ+ToHYZS19khW4mdH+rvElBLbJX58rNXzSvwDrHLa385UWna7vqB2LHV
UM66tnzdpVCbxhFf3HfzWzwAwKmmpseiMbmvExYQuK35evJyPFVTPc6kKNH/0Nrdsbzx4CvEItHD
oWrM75Do/CPnLTx02o2pu52v0YKF2JYMCHz6Xu0daVBTkeq89SeMtnZnoAL8dPGPVNe+1+KmqJrq
6AqvfAik25xI7V5IH/ye+xoRmI7K4ETvT3tTq349TbNWuzYR9mO5Iqf1HqtdTtrgmJdjegrGLvnh
zDR7Co7BHlclzYzWMkyXnFeMvHY4sXtqbPGrHAXFvUsTbkM7n+7HvigeFuKcbpDUO58QzgF0UHPA
2GvcdFwroy67ZlQnj39EfJwDfxOKz+ZRnfO88u8oPn5uktoQsdOHg7t1V/EbheJRiMY94sgb93TU
32QLQJWEQlrVtoe2s391lt5QyXUPjwCTPO/LGlLoExAb9mHFQz335zSgFs8f5t0aLtOZmPRK0rFr
N5mjDhBv+h2me0TUijSkmWP/tyE3a75tO+kuj/bCGb+UXszqQoNi9Y+utYI9hvD8EroTvxVYqc0y
ueE+y/30dqaebsdb/+owq5KTN9dqk7pG+uFaWp/WlbWAWEpQOKPf3lrkvPy2Fps6pIurEssnDrLp
ISCbIfPsWQ6LGzWGfaFG9rAAnHnWeA1ItBneRKo2W/eJo3+3Y/tQgpKBvKC5sv8cpIzTIgOC0UVl
RmaumIN4XrPXtJ/iUZuXXFon38bKoLxgB08uvS3YmZCHKB4zv78Ji+mUBfCATEmHF9T1FwwFh8yj
g5re+zUSxDA8vzwXfbgc57Kz2RgOzbKH7fOjwEpL4nKpd8I3770p4GuZd2HrmDF977x5pXwHtYmD
bh49+I0LLtMVAuyWHrCSc8k1H2lZDZ9phhAkSfOFoCYXJtBMOSqXC8h/Z3UpOnEzFu4QdzjAHawo
VGsfV+r1sG7C2q02cvCqX7azXjrszVsvq9lyehLteRzI90NX5e1cyOyTjuzq2CuLxOatVTqaHTCe
mmh0EIYyhOJdzg2Yw7o0z9ma1K/BRMErgYokWiQxr2jtfWjWe56gbmdRMXQM4C/xStf1ZVh1RmTV
7fTJZm3xLhvb3Am5hBVXu8EnvBgaD0bD6YK/ApouHlSuMPvADOZf48Kl7BpXMRgk18ICuI7ajoxK
5MAhGG2P/uuIGS7cWmosSB+NQ3pv2kpd1sH2Dth5nIuWgvwTGRycQxP10awmurEg7XqNRcFLbgkq
W+t9WCzuHaWqM5K0U27XueyxLCL5z5pvul1bQCwJ2McD9b7cUnMS86kyuXi5TlTVBfRNd9QvmASq
h2khpYoj6VJCFtgsDp/dlWl/P9rdgg9XyNtF6MfcmN97+sEeAkZwlr3lhRFwvnF1H1QkLnGvzyQU
d6xzn9Kh4AOtLFYahXwxgV3HsC1ubHPF3e5m9RYAgRkT20gvTC30JPjN3TSYE/kREJpti2M0x5RF
Sv479YxfsG2yU+aP6Tbzc9ITxnHwiukXyP8+Fqhl28lc1XFur4BbmxcnQubUPPNtHd/rTMM2TMNP
aoz7HUHd8tAO4rWDBXbHFcg5TtyHrzSlJzbFvMIWuty3JbRXyr45XYlrwS4ATpgTvc/W7CYQvE82
o+iKQzWPzr3sq/VpEmt5cjIamhc7uIX1D2sK8/1xdHiXiHxZnmsEiFcLyud+ghrHktHq4rHLwx3O
L7ENR4OXa6i+Ju08QLLo3uqr486viYopK9h4k1k/JInRba16Tj/Dwg5voLqZb7jk9xm87Xj2+vYt
X1f03iYNHgEvPFHrXr+RUf4yZpOAKPv5UBbLuzmMu2Kc8kOV1i5tqgN4QLx4j0pbkn1Kkn50yvc/
WtB9F5m57o+QeHZAIyV8zy5NxFMz8YilXquetLlWZwMzLX7YMdS/BSTWnTDqcf+/uTuTJcmR7ch+
ESgwzNg64LN7zFPGBhKZGYEZMMNkAL6ex4stzUeKUFq47cVb1avKSA8HzK5e1aOlMPu9MficaVZv
oLgr/3Ox8vG+UuyfUs/UXONzhXPVqV4Wlx87AEv3bE7kQXBo7E3pCNJjhDUgfBuslefmsy9VtgXp
LrblPBb3k2RjxP68pkpqMX9Bwbd2plexqQ6a98mexX62J6I9+D9bnbGezClHLyqvO45OOEbSt1Bw
kjWJWn9dT5Xp0/rei3yvpnwmcT9aPm+kEGwiCs60lyQfH8NxiIOOgDkuCVpjvdZcH0o8ACyExxy0
pFG+rmV2ozF4Lu2W/lMGNOy0mKyF4fo+ZsgtcZsNIp4LQmyj3REcmykgbIkXwHxWR9Mvt8VYyI+8
M8Xj0LUvMETUebbTa1p7uA68kTpgZs2DPQTlPVtCly0Q0ATDTsMvQLI8b8H4K3Dm7IHCAe8sV2E9
i97OLg5HR1QC34q9PAWBkSyvSRuecOxpwleZ/VRwRdqlhgmtQsxVDBtckrLv4LxgZc6JXifLyzQV
LNXLEQcHGT4EIOEw8C0cNH9hEpVbrrb5Q1uTlGNMZ7pMENXvPILxEBuIrhS2HDdukKVn1ZIibRLD
POWKRi5GGBIBpOB53xnw9CTQ8HxaJsridX4ZhXqabLIvyGfMPqmLDEB3wV2pqvQaFKhZKUMW56O4
BT9VS+1DHh7UgtWQuueUWm/QlkUp3afmdv/JNdlnx5J/WJTzhCrSSmVI5jExhb0h7+YfteZMtaQy
d3bXQ1BXJKKylDkUTjGzN4TEBSMuBxGZtMidnW+VNh9EAq3XNevGTYNZCa7BMv/m9+WeqAK7Dcr5
R8/Q/8HX+UjNYx75a5XtihrktjFNUvHX9+qjI4tqWyMUII+G4LYZB2HsEl/BCmmbNIW7GUj8MJnt
EwXNLtfoNGArXFzSKQj2iZtcHct8smisiAqktrsxC17bfIphjYZHGQZXG400mhXpT12WfFJN+Bgm
LnnXcaLQSOVf6CQ4utuKNdlSOmfSWgfs4uumUOvRTKvPqb5lEdTQ9/eTGeI+z4G6i8y/X7jGnuFd
yCWCvVzp6k9mAWWE+TzegtzewUIs+ATLiC+1wl4z1+sePPyZFJF8NkjL/Z5up/Ngz9vRkOUzQblL
5dFjn5CA3AEDqxEVyxeEo/6tH0N9P3IOxAsgsr/MB1+BNO5a0fxp+qz5AgvUXaqlbAniFMQP2pRq
FGHCvAaW3Mc2vPeTL2E2EKt7Z+uf76kZ874K4bkfs3bMPeigS0XOIOIlQ+DHWjHLgrwBbkH258AQ
/mnfHDOjM3x4zvyXr0jCY2G3yOUWLat0kl0AZxM0B7jc2m2xc4fK+SFaqF88RB32sxNW3pCVPcwj
NkYjhd1pXs6HwbD/TDVsyE1Qg4u1lOmC8Jnq1xlLCO/trHsoYKYdGdm8mIPXiOWIv19KyyV7m5KU
RkUhD71gI3KBjHo1IBWzNY3YdVjFrw5dzDIU6lVNSCMASGBKNnp9tBynOsnSYgI2f9YZHEIogPbj
rgMuLwujf5bL+rdILPZsC0Grnnama2PUnJUBSM+5tZptZ7gzVEe730Mj69iFT/PZWkNznwKQEoSZ
9OK/cz3iUu7U/Z1syWphqHEuEHbaqMUuoTekSPzPJmcADmX2My+c5TfqU9xPHhUcxSy3fhL6l5a/
XBTQLGRm7huYaipkiM5vqCUuNuEY+hy6dr0v+2b+qgYx3/WqrQ4uKYtY1evHSJc2i8fRv+RrUfNH
W863kSZGZGJ2eaxG+nMLMlKxSIcavb7HMsf4y/Yit57zxmx3vWUOSAq3uc5eSYSOATOhkkYHLjFw
mKt5x/vMGVsK+h6V1FCBOmw1vhXUUEpXdVSYu45iCEXU5dYPChSsD7d47rHpbqhMvmUCrATbTgOZ
gW6XWA3JjwUq80yvnnegvX04WAJzgOowStdh9+DhZkJpscxIe7nLGdjXJ/w0yV0YDBYkj74g1uYh
d+CZFjpmpc7ERPSGWLtNMQabg0fCBi0ZgrBBrutC5NGqp0c84HaU6DCJV3vx46mfyU+6RIRIOkWG
QXkqVmif0Kzso9AjYYXv6pMTzyAJrc1zQK72mFra3tVgsaB7HyW9v2eRznIPIpV+ysTn7sj74caB
gpO4OOxOg5JoZzGjLEFSE3tb9TNGGym2RIz6be32r206v0EIn26ETeszrbrfVevdW3XSsQ939dsw
hP3tu9UfLcqA94jg9/MKV6z0nG/Af8BwWtqdsQ6WO2nAyhqrZY46T6uThbP7kpBO3Mqm8DGJFiiv
6bTv01mDLCH8Pw0LCqKTfc1TktgnZvYhOdN5BoJpUn3W7mG4l9OFprL5mVY9190RmmeVn8AeJ6FY
JGYT+5OVwlaxhLvc9/ZaXHLb5JP1EpusY1moPkE3C6fsTfmEGEsinSmGxqJoPmZ4A0zQ5myDV/Lq
4EOvPdXiEhH3vRJavuQT37eNaiRJrZFtkIo7gKcjwaeZmTDIhIkhrLf7icOyMlLmykDfLPG15JXX
mxVTil6KZ2n2BEGprA6MR589vHEqutaiW6Sxbzgl/vjBeqTWkoG7UDgVYhEmo7zaugO3qnDoMDaG
g8jOcnHtaeuKrmxjXppiPYHkoixEp0vVAbHlWdqsmVfPl9ozR3uzGol1P2Bj+Jk8jw5JPZlAZOb+
xkrIkZYfUP7Dg9/nJBGa9KVex1ufuMc1rb4mo/9aiWSN+goBLtVV99SkLqWj4neC1568jBi2E9TU
jTn7f6dBrG98EfQr+i1BLHMmueNhlX4XPUjPskDqwEg773ocgZQdlLW7ITosr2HRmymo23xtbtfy
QA2xUU3F24yvcni0+rHh+wCfgBYchGQSPFPzlCMgFduUCqL6uem0PJsIQtCkkC37Lq3fcSemelNr
OV61XO+qDCsKnAoV9Rl8r8paDbqHdPs2T9N71dYvtYJL0QWl8zTmhvskxdJEVrZcZngzJG+x7wDr
4W4xuM+EIxgLeElmvJTwN6hRNg/1kMljGRo+cieS+dvaJ/7RloG7U5S/fFiw+H/spIE5ZeV4am3p
QV9qkw+i7QsxVqLv9pQKQG6ZS+g9KX7CbqT7KeONEbAzaHtxDWYoTniqNUQ6y8PjsK7SXb5qD0PS
oc4Bt225iiv3YI9Oxja6T8LiLc97cv5kFub+mGcEJgB+StXZ5xmHFiUlrkhU5LB6ZYCwOjEzImMb
8+PGsfhxNxNVLGHOC4Hw/NS3O8AXlK63I7jHl9JxuxlNrcw5VeFglWAwsWzQvbOqQ5pRJ8a1KPW1
vgRKf7EKSoA78LvZDWuYRaQ91+06ru9z1j4gTZ/YnpKzxam88Ze2O4gVpbY2iwBPSI1vUxICXSF6
nthR5M4GphK3TrfRe4gQ7s5OkbFd3nYkdcs1GtPgGk7gg9h3UIuS+b/SrruvSApGaprhfmon3ZVV
7x3MdjbuOxyLbNbbmTqeABQFb3fqjTwxqWMiZUAdfV9bZ0xZ8pMQqf+Rkvq7KOHkW7Ha+jNTQXaa
kUghaWSosrcWzMtQr0TsxjAgiDmnpzGz63GnJYF0fj+wnjdgzdnxUr9hxBVfGTrHHLve0g9D5ymp
I3GLbz9hpv5coWo8sxi41EIc9ZLJcefOmf5ZCdrsScBInggqs7iCN9vJ8pKo6ofeJ2uzWNTjBvIe
2w1BojUwnI1EqdpBhbHR4/HoouEj+byvfejSt2cg41KrNP0iaf7dt2jMVTd4F2kD+OLbRGrwVjxU
SKu9AuQbfk8yuB90EMbFmA87bughgJN5PgV5RpAora3HrLXvvJAEYjcs+2DK71TZHzrphWda/KhQ
oaBL3YfBxHKd7UBEhFxHXQnbYFOlUgC/7ln7DHiJDY7oF8NP7th2cCgyTD8Cq+voPLOqJ+JnV+of
dtPqnnLWeZ2w+c6LrPmlDNxZzeJ/uRKd2nHYMmVhkT6JJfMOqADZI3VZ7TacHMoAZwv1NuOHDolE
LlZY/pYrefpw+qIF63ZeoFDanq03qAEJrm2KkOY/vG/rd0iJmqdRJTvPXO4do3fj1B+COjJQCOLO
LlGRyK/owyg795kiB0cA+KuxaWhhH2CeA5tcS+sFVfZbe+lr7Zqsv3juLi6B5QMkxzVegpUqszq8
A/VPEFzyO8SLyF2hcseO3FgdHNXMrqkj7B5XsCg3yYSjrh1s424UbncD7tbn2VB6mzm8n3mgA+O5
Clr1PE3lU15ziU1aeEMBu81NBhIeHxiYhLSCeiigZR6b0X9vCgx4JsD0yCAxea0NiyEwgf9uYTJL
6UbcijG9828faic6f8sAV8RmbS9xzm2OlNZHh3nlMCUj17eifaP+CINLAMq/EPpLFwIPlsHNPV6y
Ar8ar5Az7Tn1rUnOi53U+9NgvGWJapsvgGws+hOnq0e7ADWyNbVcabLjL4gc7RX/SGV3jVmiHTfL
lpSL8ek78IAkL60T7pMafMpaNzH1kdnLRASlP5egW7q7peeahO2dwrNzjdqffHbEfKmfD3GCn8uB
bPc0CYdz14ZKp3U6k2+3z3DAGD1CyW0Xd693onjSyl9ZfGRFVIYMwody0bQKMhFm6nfim97ZGtZ6
ePnfuy/+/0yJiRvp+X/2aJxJNi1rP3z9F77wP//Sf/g0AvPfLKrE4fAKtpNh4Pxfn4YXEiFzeCuH
dFEDxBT/6SZzbP4R4S3GM+Kg//GP/o9Nww7/TdCq8U8XjYtn0Bb/G5cGVpB/iYlhb/Mxs5kEtzDX
Cyswsbr9q5MMn3dlViCaDpMSHYdB5sb4AMLt6sxJlPnF/4tIb4sbGPm//ZFeaAvibb4PHsL+p/zi
X8xrNJawLPGc7MAugoyjj965zbnEYiW3LJbbPc15uDmMu3lYx0OJvnb0/dzdFq0yDnpp5Fl3NJBX
N6W7Svv8QSTls5cJyC7SYSs6FEowNTCubCZvHK5FUXY/agbTu2EIS2Ic/c43HeYsQdypNnYjWagX
WvF8kBf9zWXJyqrb17P9hsBC61xL4OnBn2GIsLjMsfmHSeN8pEC6/3BB5kY9BYhsOQXpiv+gkdw3
nJib3nMZZSeyCHWbQrzpg91YVXc+4xKQmsG13mVeON+C7c++15Q1mRYvO2vGtKJYqlSRhytuuyK5
PHL22+DrbzzN2gcJyLbh6OZm8BF4+mcKJWIV1zB5MCnPoT7UxncWj6OZvbh+U51Mdj+wc7X609c1
WzT4pyCAs/slg9oVOui5cbo2B2cYfufYWohW3Xh8PYXDnV3kOyxmGwedfjf6xQXLNwyQatpmOSyO
IvXeMTL3qr4PAtC8yq3GT6MKQZjilSYty+Zt1Olnb+D1zdcroN208771MNCeW4inJZGf0i8+JGoB
LD1Aeh6UBC+zkAJHwiJWg1g9A8hdb6uXxoVUsPrdbx1KMFHkK0I817Joq1/cNv3N2gXGPsjyqyvt
buvCWi2b+tzdFG6/VMubM4zclF1oLcyrKdUzbIvcXMPOWQ5YTNBXAuijXoq/sUn/YlmOmdQhxY4J
20H1ScJlmy0lHJHAuChWwETINOf6rWmzCr7ZuCHjdY8jMb7DELhfI22xQjmcJtxyNmZdO5FtJyGB
sOVQ6uwDYvNb5no5ZjuDr+GGk/SQmDa7skSQ3641LvsetzIG0PFAaaKx1R7p8rmjHi8q18L6I1lV
ZUSEQ/z6HjGb6dEYPCMqNZw5ppdjiN5rAgrbOOOAe6HqoCIubAdoSeML4dRLhtRYBy9Mi/l2nSyi
6075tFqwIFCG+cAUBokqM1nqcoGMTFUYZ+qJx53hchfA05IDvbwtlDzClGSlg60N6GdXYBUke1Rn
05bl/FV3zrOnreUDyW/ez3o+5hz0mGx6UHQebexJPtwFFo/Y2tfJG2bR+n1wn9xsSfY+PYL7tPLC
56liCexRobDEdZB3D5J/glORLAIkOOZx0PsQCoype1099q3TWMeYj4DikpTbDR47wK4Q4sdPppTL
YhJBcxoPbdCn9/hlZpCMaO5iyBGxKSV8lKaSJ8tpuRXo0P4yAKNxK5kZXsQFhzcb9b5+0qmoIgVX
8pj0yrvSZpru3AQ/DXiICOP51W0rDODFYL42DFWbogYY7KZcOSo3gmmtMBL52D/HaKVpoTOX4eBO
PsUBSazC9I46AcRK9Hh0FBmi4d9XhJaAj7VApvGhKb5V7oRnJjX1a0HxLMGBmFfOcuQnna86bN/z
oYrnPCjuq0L9Sm3+OnU3nXqdP4uRDxKbCYBSptJmPmULA89IQ051Wf3kcdbFHVrKiV6SLSb/t6Vq
XQrsdHIH6CrKi+yTQTgkzsI0VFfyLS8m9rvVafCab8qgIatkuVdew3mlcmlR+5zGggi0Jj+1+cvz
VHrm7l5ASIicSYNH5dpqRII722DCiasLcZnCxjobhNLjwQm2FXEjED02t5iVJCQBtdpDrpzS+kot
0ZYKGFZ2hox8Ns174waEC4D1sddiMAuaA60xTTSYEhbKnB1M88UY+vwgWHzxNshPdrd+SNNQcTOU
417VHd79xf0w8/Hd416/+BXQLyfgbh9WvP3MLDYoW6BgES4eZrxfpep/LQYqXM+7Ja7c9K4IUOsQ
6efIzp3+wGXtya4XoENOp+5X2q/asgTP3jV0ogfBi8z7d0AW8gKK7XE2QSzfXogJzMwBLJ8ZLGCC
fZil01YEAR050IQ7g2Mm9LCwSYp7bm43x01jwizLTnpjQbRiHE41c38XlmAzNXsOMoodtrm4TOTA
Gq+uNrSu/YDbsT9ngusbs3WPpFNw9/bTB7XoeO5K95PKyG1gJCZYmMb8kN65c3rjfvZqUtMik08u
/J6wOXnDTx/O/RtPBy/C3FvuZt9q467Qzb4kgOb3brp3e71PTVAMwCTvoIw+rISimxq7C8HuV6pA
mHukO8eWi7xfTLb/npj6DFpk2Yg8fc+0cSaYtYV6AIFmAQKdqHE6laOE3ylpOujb3H0lu+Q82INT
P6yd2JNodjcJpRhbZ1h2ICvweJXDB/4+nHyceXSroZigUTGeVMPtl0drEspiG2LwsCDWOVG6Qv1h
w4pz0heHvGRZW/VBRIFECHeccKdrYiiEf0YtX+vvAynfq9DSl6ZgRtRsVbvFPntEofb90v4upfpk
7xGriYFiYrUIYKNcd1na3TXsKm3Lvl8MUDlpWS071LJ94cPHb13xM5TB0W6xFWaS5bbvTQ5/VkBJ
0wjLjK6kOCnFo1JtHTWCGLEq1KsUxQH5m2VWr/xry7b02UPZ2+GDyiOiuiOKNuBtwds28gBfGXNj
PaUodRfAf9jWSQhhPPCawzqb8k1RObfPsnHryQUYv2YzmPlYFOiJX61lK6cRF1xf7GztbNM2QOYZ
cxyx3hrel3TRt7XeQcybTp5Tb8PbGox0O7FVgTBiGN4WxXyHhLgxOvrXK53dBDBgauXkLOi2yX7u
mh2t1Bo0zNrHzmC+S3csKAmllhrqarnYYjd7nExWAPnfyV+Skb0IV7greCs+wnRUOFjcIDInI43N
dpDbCd+e4l0d9WsyHCjKiobAY1FvDo95VtEWJBsYmqqKHdLRm6CpKMBKqi2Fa0mQltux4P7gh8mx
KnOggT1v40qFG3YD6CK9+dwZ88UDGwp4TNxZKSKraFR4Yf/ONas031tWtAzEFN51wqwOGivXNuU+
ck09bk2YEnPSolBnDgEQu6OvuSxorMgb6U8vScORVev6c2K6ON6Mcpt6YmObWSiMtE+kbg4jE1Uc
9StLTRT7pItulSYxnBLxnqaqQ3Xp3nhmDoIeGtZVViw6XXwTgh92OV4qMoS0fngLUmSWW79Hv22f
1kw99oKPzSk1JGRuWCIkcGzgHfZ9H5LYMxdS1BScdfhAiUqVBB3T7Kclpvpo1BiH5qm5DpWiyLHZ
aOfmZZT9P9eeKjIHnAd0fOHSnin01c18NLL621vHYTtmIZzI8bMerODMirTbEqS2dnY4Z1/a95zd
OHliRzV8l7D09aaDZ9GbuZHm+kk6C+9uhgc1T228boO5XIyVC9ug+VqtQSNeQ+X9sROr3ysADJuV
6D43SNK1RWeyHFYAVp/pXiRsYYfNcq+m7peravQTwhLi03FJc7h5AiHIKeVDLoL5UHik/MP8OAj1
7PvLJc8XuoCnQj3XuQM8TATu37EAE9C1bnMxyhBuUSoKatpAmPZ4STeq6teDCzy82QzK+saclNxw
CGCdARaclkn84LD9I1ZqrZVMzxBo4yRRny5wiIdWVpT7tr2/J3/fHir3x9acGniGHoJgeR9SM4hW
VTss09q3+jabIGeCNWO3zRZzALjnWL+zvj6E1H9fuSTufe7UfkFFbbrkI34s7wzZTUDZoA5OVWgT
lm9O0IbvAPTxuqnt7wzMAwb5/kCPeAdawnAejNGF5f8whXZ2NSTl1RBviseiHBxEb77/LpSwHKoS
H/fVDU3+Jz8D8yvMh43jj38x3oiH6mb0ARz5BtXzdxcUT31q3wlW93zXxfzApqTZhDdOQSG7HL4X
6GB0EbZhC5aajS6t+bwIV59sbjEPuC/X+7TBuCEGAEZuGgJC9bnbS59QexfUJoxBsVNa/dDdHNFD
fa1X1Lwgo2Sk7LipcZ6nI9BGpyONy59hb298s6sGkftBRMqIqsyYXpgbWQa2eRgxyI4/RDqTF+wD
4smdGv3XzmVFXjLQd5Y0LQztwqtQtRLrkmEvlDjQ6btcFMww7lnyI1tGtWeHC9XEnbozUAaLy7iF
gUwajxJmME68ckc1L4URIwQKW/540gCCBr9EFR485SB4y/AV7MsJPG49yV84KkFSJTdHrOCsI/3L
hksmMXYg19hUxXok5xF7mI2r26dacT+MoALT60Hl7kpr9z4YrelSFvI4TtRp8+SNd5OZyh2SlIxT
3G1JwRu0SUbUzLz/AwUWKVDQIhbCbBvR3A1VvK45VL/BtvFRjL02r+sk7qo2Py4lHPVsqfyzNf62
m18ejCgoHMwOskMw4Brmdll/hcZ6hR+2CzQ4QVsvW5Wuv5oVPNLGJWZ2HyZleHI8jYPWdrASFs+u
Qy07ARWb4U+jctfL7zrjYQR33PwtyT25asabbHNis5hN+VfDlKQG9gPnLi+wViI9jwfDWgB/HD2j
uuaNZJniWV86tNytm4n3rAsOdjbdMaeu0Vp1312NXQz1nIIMpkvWmZvcqUYsYeZyTi1juJSDPVBR
2mO/JE5QCFvvV8PD9JD73QVUH4Qys2H7Z5nBzh3rqFrkfXtz7PExPksP9aS2vMMYOOy21pqav/ps
ulxh9OrOpyQziOzSAvI+k2CP5lX2ZuRDLcXgQMJtGgb7YV7w61IkHYAoowqKW3N4LUbGzLK11X5I
lsecmeR3mdrzTrke7T2OLl9CXIq8UW8DgpeOS74DGNBt0dNnor918hyGksVywoZzi1Q2XWaC5S/1
QMu2ecOGYD2kX7Ks/ezJShSscyoBdoyS7V6HJWXD9MgeQg+WvhuUBs57S9g7YERqnybhlfXCeMGo
6iYx6FWeXOFrMj3D9Cw7Ss1TgV/MNWHPYSzdkVlrtymkYmCU5bvtTg9ES5aooqjhCjq6e1bYVSYb
hP/AE0wnBHiaeoZxvzV8HWKkVKdpTHUkWhucH63zGGDaKWrHodiZcwAoRov8LVmYt6GcG/vRM0kW
FtxothKPuj/bn6nNmQrSvdxwBWBuFZn1TnsOl03lldR5VCEcybz5nJN0HyZYkANJ80Y5nnwPFixu
KsHAPpqRB11hN8LjRvs10lM9z2GcOhVYvhX0w6IW+iO4plWV1x409zAiWDza4Wh8zpJzppbWC+yb
M3yVBlAFssxC94+3JC19HTyTcJpPpo+e08xFwTvG4EGafGNHRVX+SiiasLayOFTp8xjTv5MHwV6x
G922Y9Ac2bFQzeWjkYjSejVHCaeAOsNNGuAvQTBdjqYIr7rnGMiIbmPRtCr+v6ReN/R/7kVCODVY
nAaqJkGPLJ12iPMmMwdmkpu3fb8u8kLP68YqwAs3Tg0NwAvvWs+sCWzXv+cKC1RDy9zWTLlGgYk5
GT0OsXwcqaNw86vUhPCT5hFC4PdYlTuzTF98WWRv0ChuECJDRK5Xa0ABufVozulDZbrhWzCBkXHx
2900MKDlxq3RYc6Mvy2dgrD93FcAu4KqHN/etiZevCI427W3WxcR3oLlC+aI8lxXsIvDvOCmk6bP
YrLu63YGUEEvwtiLJ26p2GCEa56lF7ypHpUSdCVfyvSSkNwECpPHuQwefN8jGDY/FfNy5Ny/G4d+
O/feDndrLC3n0Hs8ydbSEkCwImctD3gAXhLgUNnG9+AGUbr95CsyUq5G//Kaot9MHBM84yzeezhH
bBnSSwg26StxZoTDAWTFLq/y9FeajUuse8wfCCvpDisCNzJ8BtHqwZau1ifRp8ZXUhXZdV0a2OoY
4pU2/ThLjDeBOvotW04dDJknIkc5KS7Stsq2s11S/q3n5sgQKOK0Z5e7TnAZQOp1Y/U2FtMBOaa5
1ary4yWpilqjSqmcdnYElpuXnGBXNBcBbpbSy+mFGDk/LHu4m93ZZzFpiz1QkRfq0Dymom5656/Y
Hlvb+UDh5aeDFhbXeGPYNLXNHuujt7O6IPtuFv3UIEFE5czR5U/G7vaJxAq5AAcIcsKwTi/s/Hlq
OoaBcvSnuB1njS6HsAktN91lS3Nv8/tGnyLWgDllg6437W0R7sum+4sOk21FhT8HChhFWzfXudsI
RGBdTp+K9+GmnNsXt3OOXt88Fb58hEImD+viq0er5LccLs47m7sHUDDJ3ZSP1HvQSoM71dTxqJ36
aQSP/ZRr4nZBk+8dnfxqZXod+f5SUmQ8jUlmnf1+zR79dThByA2x0i9HvWKh0Bir8KN1UYFDBryM
geJVN1tS06duGrYuj/WrkWb+b6ndHomqQuWzkVqdMbxgFO7udcOdfW26gzTk7xHHbgPoQbQj5RUJ
B6cVnnRFcF3W+Sfq8Wtjzz8FVc0ggxJ1R+dUHBAt09LpLuxa/NgVcn5srCqkAAcvQaZv7SzcgBTA
DBeIMkaZg1tC9TVQgvOwG5gvF/1ALdR5giMGtVPXzBF6OFID3GIWPdVlDrLMpTugNRZ8O7hWBKbi
2OVlv0nxpUApumSBXca+W0Qudq94EuoTyJHa1u585EJrRA67gRN/wwnif4GrHa26s5LbIKRhclRr
ypzSPlUDW1XM7Qb3c6VfjUSOZzIKJzb8ADsp+rnjmtgjLpevmUZEzFysNmE4+y99d7sJlMalLAmz
4jg75BO7el2lD5YNEUe5dyp0JtBL63kpra/MHx6sZfkJueMmOeUMUIFOFOOiuVEnEHmIzz9NIh77
TpxpVwfDLLPIHZKdqlMgu/2PM/phnBh8rkzrmC5782kAp9uu2twBZ8t3pieqbVHinpmsYWP2eK0d
U1X3vmvQi0j33t86YIdhLU/AXCPP0wQ4CgjrgPXxlUiXPrPcpBwMQPye9je1XQdeTw5xqG2rukvn
S2fvlnAfKC7iDdG3Lh5OC4Qt95akXe/BdGP4n+kdazWVff4veg3kpVE6iQqc/7QM7CryABuPG+iz
FxjyIc0Me3szCuPRzTCzd/nZBOmBzMUcUzQ3zQvbXlqPz5VFc0M4banBy7mG1yMbmOowlm27l0l/
aqATcZ6j25W8mcwRi9U9cALoKDiLdmDX8AO3BXzl1H4wVFdTFhGuoPzRP1Tjw0gONiRMQCJoaz1B
QwaQCPZhZ/Dfp0IAII9NJjSkG6oRaCzu8t3YxbfdedgMrfKR8xKUuUz3siXUWPnqEEDk0/ZbkFnm
D6paydAQlFtGv/w7GI1fCdegTYeB5NhlNHz2CcGtfuLGUOZ7XRGGcVO5twt1HDBV0GIzVXtAVce5
uC9ufJ6xvQQeLkoyEYRCcIoY6a3DQOTNHl51Gg8iv3Zr1dzzFk/ZtZnZwXKn5OIi/R1Ek+bmPly6
HsnpAz8V3hQkHJMmLPtVMr9vSLOevRY3VYWtswgUW4hhUBcGiz9eZT+nbLQ3fKxQcYKYS5poMiLe
Bf4RKEFPmRgw7OeQzkAkxUnQdVGWwWrQXGyyVnOlGovkqwZsuF0kGGeoF2prCWuArp/zltNz90ap
X4Uqph31bC7j+MJW9iKL8R54sP/NcEnV0yquIxmc+s7FOn0zSGXFV265R5ofovm2y1wAMDSplzwR
FvO23DTJDCTuyksK8DjlUUtHszKLAlVXxtOUqge/N/841VJt56KukfqnA3uCFguiA6inOyNOrrw+
xz0uPF6o8L++DMe88xP8aOISNGbsYO07zgpn+qZrWP9MJd5/K5l/ywxbJwidD2slGzZ09RPSLO+C
EQUXy6XtZOpJWOD7ZV0/hLe2LFKkibb9KBgCk/CMfQjLVxopYnSxJ96Jxr+zdya7kStZtv2VhzdO
S9DYc1AT7xu5XK4m1EwINRGksaex59e/xfsqs7IKqEHNKxNI4EbeiJDk7jQ7++y99rqBurtuoui5
MPnsjMmYrVMJ7Nv0ge76YcuUZ6W/mAgYV3v8fNj5jZbGUcwqtwVtF+L0Yl6L2CWI5AHne7epRP/U
p3ZNzC2itTDfjX15EJUklLsw6dt6w+BrruEnUWyYhOw8ovnb59p2irJv2Wr8VK12aJYdB1YnRoWN
IhV7IXJxP7UO3hx1qYsxONgDqwRblFCQkMrwUXa9f0y1sDZuON8ro9f7crT59bgNMbgEAQYXXgd4
Irvcqe+xkb0aBrIdoSAHSrr/3JVsHyeAPRhKFBNR46Z7lcOUbALtnOIZI6q0g18G8f5tzIG2Tq1+
V3oPGOVPfYnpkn3viiPH3DaIe6AksZLjZZZM//mFBN595ZvXFPrWOu6TzcxEVFH+ajcdPbxWgDPN
mA9ysIiyVBLDnA6ZF00Eqjme0RGERdLY9q2n0DBJP7fBKY4mPuyElhAY1Sa1qZ5DjdFhiSNpLCue
N11HKGWSd1Zh/YFnh2AxckPJCjYibrALuzLEE+3P8dEyHUiUXlc3O5yc8R4bL2Bl5Q3mbrEyHgI9
ymMRctFh+RSSq+FSH21knqUPbVLRclAn5gvrV0jX5s6F59B4yQNH5qGBu8ObBBMpLMMpRSzx8P6r
oOHjPwljzyzCt0tBWl4Y1bvpdOaTE+VvfTUPDw4YyWqT2z78glKTnGgj6QBt7YdVjWMs2fqTpKAq
AO0nEnWNTc9kaIAiC+3PfAiHavrQLoN7U4UYnkX+C7222nBFFRAvPXW2VEy7tosJvJ/jxxQGLGmt
8NMU9j1h2s1QvPHKrgMqhQaHZsZk6HO+BPazqnvBLLwfTPKcQGBZADsHbpp3c70sBLoToz1boBx/
dkM4lwXptQqzx4kirMe6Iy4DlhG73LgvU9SHzMFuQIzDSN5dziUohw/ZPF4DAq3pumvHmiBs9N1Z
n51bs1Re8sRIlgm7zW/HvseotephAOCVvPkV8kCSWKdcB/MhkCAj4rq/APvhsnoCJ7CLrebiJNWZ
nrxtPnn08aBvPZKA//El9ZBiTFKseXzJ6fQDVXfTkwfNNPPpXGqeSN3wEIZLOIb4VwXJtRfxdzWU
r5ELe7Dfy4iwRMXkmkvzPQxwtYKGOM4ThVKMd0NAfAgkYBMWzHkS/S/oWU8Y+N1TWxyDtKRzyuIx
FlkQKvAcvOdieARvuRW1fZ+N40du26jY+HZ0RdFvS+nIXD4mMMhOIFUDqq8t+Aj8PIYptM7aYsVR
1tdqZtH4l9Ca46HFtOc8kLdg2dRRT1fgh994pmsQQK15tAb4GHPld7+mYgg2LsFO/jksfg2Gateh
I8DfSe+snPYC0+Tgu9n34Fg3Qd6FdY2vL5ZlHCPcm0wULuTurNq5pL1zk4C8xse98YX61XoE0T2z
Ty91Y528WjNsuKL64xTkQ4qeiMIq8EDuWaV4a3FirrwUu2s9MQyUVgZvh+o9Ad9u/ilSGPB4lPXO
wrjwPFO6gc1GEygiVYE7PRgH8ue6tl5tc8RdMbl9tI+kKS79XxuKzMncZK29iZey85P8PSHe/joS
5eUELt17bWP82CtJ93adi18UNXk3QMfFJWmQGQlkM3CPFnZ3szTbe4oA4ruoc8VD0JvNe5Z4zlWX
Y/AT9hS9YnUc0jskCGMXzj5rjKnu0mJVpSVfV71AotmSbx2P1s1GUWzDDiW0n5veKfeyHz32wSTw
vKnCygMbisXJ5O5JM6Q/9EENa2pz0HZqs6H7ObHoj8uCeNgT7B7uOysb9wZvxp20lHvNqsJ6i8xl
l4vN7t6jhgskr3a+CUvejZbsvxFy0/UUxruMlVFuVId6lPcAURNCT7TXtkVpfRhyMh6gWna7Vlrl
Fqcrl52MaFckcpDTJog/+lv209SSMq0n59HyO/mTu46xlUVJ0GeiutMvmr3v5mwAGHnvwsx9DZz2
Fy4Ck9VquLMVzO3a7u0vEh0UMlyMYLxMNu8F3kHJR4JRmo34gzNiWxfja5+jGY9OTHt35VFVaYOF
NR33MST0uk34T0o7Umb8KaIhuhZJzTcJAusu0LRjToa/9bIgQDMdceDsQmzEd4Xx0lRY3zcNLAa1
qpfi76pp1oNY+taSmrYwgrXlocZyaecu8wlo8HMip7Nh+tSxdg1lUtHCEuFAswRx9BL+j2c27IHx
c/3YZp2tUQTwzJiYDzgeNiA+sg9lMuT2Yz8w3TUt5v7EuvkTKoQiHr5WbXLo6EdFsxNE8XvbPSLh
+5hFPeAdru/J57jMerLkFV/0EulgeaiahA2dr37HddNep0bKdilDntnd6QQ55/9ftp1Nk8X2e++M
PU6Rin2CYxP58kj7OpTgLAJMPANzcD1RbFi4MSUbfnYaWpZjnvYiQBDxcMKuRvlCOvmvte6BCjs1
q2uPets09fKbYWG+Xdu5mO71GLRbNgS0u2aaxH7DPTqaXRq1aBZSq67V5CLcziy+o7TKid7V/Rmc
w7yrTJXts8IiAwjDbes3k/E6z84Ph9WHZwXHWg3OHZoEhz9UWfdzUpF/1llRcMxNxQXJz2Xnmak7
ATr30vX1+ATjOuTlDQT6gy1fxGDWYMzCur/ru4oI6TQ1B+n5ucWU4Lac1ZoOuo6nTSGS8lJZXr4i
ctP9JFRZPzlu172NZk2nq111dPwieSLfmwNscMBKofdM6GA4qE6rAyIWqLqofSyyQd+ka8tzzQf/
OMqJpkge1ufCG/RdoGwMSA4+9h2gg/ECgVX8YPWHiJJ20ZehfONAd+HAno/8DYdyq4CUDuH4WMR0
OgzJTLtP1ozhNbYLc5eLlFVFCoXcaCnSnbGQMH5lV6l45dvqYnKl3jJye796GS13Q08dBwi329wN
K/L44FtaFw+M7dXyaZKUNzlt3rK2YupZjeRQr/TEKXiu9JHQUjdgjreizwzk7VrJAgddOlRHsHvZ
K548QhPUnvE1Oz+NUHrtVHV1MaTUZyksqlmybvDATwrF9Sy+YtYiVoAnqGT/6UX9sYBh/uV1RfUs
sV5eypJ6kai8YGTj9ZaGWIezlT3MAWZ8rPPZ77bEfLzS0KCJyGHmQXow4v5NNX4xr0EWpWuIeIjM
RfcndqbuPqSyd4usO24TjYHOyd3kEUhwv7KyHNPI2Ce3PnMYLlus4IekkygAEbC6mznwGGoMPtZG
Usg7PlvNZvYND0I7KtgUuPbR6lqrIpSd8Wo1o89XH0TvhNOnSxF42MRQTVba1epoAI7fqdbSdN0U
3c50KG0nQSy4IsIgjPuQ7zmj87cW3nirVNj/ErXKb/xJKdZo5X457sBWxgGNlRBFyOULroEEHTK3
nWvsuw+x17yCJIJQgdt3k7kxZIHSDw5xJ/1HA/1M74Vhptd4DvpLnkzzR5t3rIDTOX93/PDPOGfu
DWyauYnjQlwdmAv3MhTJ0Up1TqCydNHGdEQ00UUQpJvtLmfQ4EDPo60CkYVxLo0fLD+DHka+Eoy+
6aEqEG0HLjDuhyhPdoksWCnMNE/KrFFnIK/gFWo6hpLGWo+cDOuum+K7Bg7smgJilCBWaDy3UrUu
Gtt8C1I7utaqGj4iZ0QqnGqqBXXTBl99OIZPeWTqlyHqs01Z18F3pBznTwq8+jZaU3htnBG/P3uw
7MCaIahWvNmDAwuB5Ybk+9lN82WrjV9U2U8OZOSXYF23jcViMAx0ei9i8tpgL9cizbzPpBtLUqIS
44+u/WgTynK8s2QNNBdrzg8Xk+o6WSUVOLnm10hk7QbBo56aRrINTq8MyLzKJiHFPcvk/oT5ikG3
8i9qhk1dmqRSIqtv/xS2tHeTUfIwKRHueALyJXgxHXV5odS160d3Ay+kgU5BZL2TePkyfLhXJtpY
HQTSFJEFs/MeI8nDi+wOUd828IJtMWlC3iUyI8UABRWPbsvj2m7wRvPOaX9av68B7Jo80CqbFWiP
NH5k5wfoN8KxNwcQyIK+BrDRdd6p8pxqB/E3Ok7B3EHKChPMsJ3Ts8Jr7a0YKuMtrIJpyy6NhVxz
s8DI4K0IKWLLo02kxlvtP5Ghj65OmszPk+s0NAMOWbxuHcoYoXfnN6LxC2CikFBmmnzbVhj0bIFg
j2Fc7MpoaM6yH+KHQoHLCELudbC5yN2RNTtQ1Fi1K3qvo3PuoNezYRYb/HHRpujK4VWZo7uqhgAC
aDRgglJG8QNG179Nk5d/jxXm8DWdODxpbdSVJjeWJjKTPaw9D3sHM/GOnR23NnAi+H8niq2J8Ivi
u3WKkO7Zhs7Hvi62KL3mK4TN+QJ2g3etHbwhC+CgwWYYVVRYq++SXtjSwisFiSz5k9Sk6jrd8M6F
0gw6xg1quD4WyR6evruidqpfFBS490n40KhoQK21qqcgWnj5LI2Nl4Rd8wKGS6bPUYxIl4Q4EDxD
h4ovL1S/c8tsNJB5Z36iRyRep1M+/lQWXgXpJcYXonD8yE4IxXimKDtqS/GqOp65WTjFeE6yHgMq
ZWpsZ937lCLJTReI7vfkhOay8RpNe13VGcyVhg5w8Fx4egwWPLz5Yw+nAv5dvFXAAE/uPLVfUvjz
YwQ8eddZI6C2qOVnGmjmDuj6BIl8q9sS5ebak4fjdsCy5rJ7I/3j9qPNGSI0Y1BCr5+1EZZRP06K
Gy8+oYRvDm/dZla1xaXRcqfzECcMWvUwR+UmKif0UN4GMQAgs3syFWroqhwa5+YLVmaNnroXQer2
xVZtuu9nQAQZfBRUhLGiG2wqCCZlaK92pYvvzuZ66U5tzrTYdHtKVFMe/3XwomFR/YiQm25YT3sB
rXUL66GFeTrSiJuU2Pqp5KIDRiAIMQnEj0a6lOvCZVkBpzEZmiferrnvvOFZiu4YOMpHmc0ACKNk
uVTCPQBKMga3iHX0rdRKbYeFORNlZfZotPUHYWhWfTNXN4/2li2f8GBdhmT9qN5Qd8ksvafSXpaa
2lh2+E1FWbKN9515KSFYSNPVW9S4J5pUmBQVbAinEu57X1ULu75VvzF2jQTruA4dp9GbnhItBQ7i
Vpos3dE+H5ICrxMeAXGXZWGGRG41yUERybxHtZ8/6zxWLwDG5JXHYkENsOvKL9ojgm8n85svbB7T
ce6h2XbskL752Om3tGVkSrsifHLbeY7PoY7fmzJzdiwNzIvXuyTmvLbtHnJO9tccPNsjIMAUJ6jg
+QWB74rLZ15XVSyPtkgMnnvya7Q6yu3MoSMa2ELbXI385NaVD1sUr23sXIOgo//Ms/FKK34t0L77
PNvafczDFKYbzKFy3MoKnUkoyYfO4S2ymoMguyZh1rA712xRfJTrZ3eJZG86REwmFHMxgI2jFu2F
doKGJnvCdWcJDGyNoUSEFzMXyXpgJIhBFRGzvC9inmA9fNtdmZTexaA/s9vZOkrfhE2JeIiD+JbX
nfcwwmkDkygYJOkGyeWzG8zNsHJZMtB1H1JPyAC9tTovejLCzqfeRNunvneblxBDzpk8TEcNQ9bS
nROlmLs6DC4WFs1NUZMub4irPFkqJQXu49EdO6pGvNoDeTPkT77ZXk1HhOduUNZ29MP57HlG/lrN
DnEekO5kelAKSZp6RLeZMJlLU1xsRfXZJXVXrtsJMnkdmclBA7zZylEluxI8+iFF+HnOHDted44z
b0KAjZtRhM5VtkIdCzzD50nxR08xtXDdjBk7pnRyPXsxY+CMhzVHVxLjc8Sd+VxJ6Bl5Y5kvdlDZ
5CdE/hD5dXjXVUH5NNVO/lP2hJ9I4vbqYjuSXW+DeQgSQ+EuOyjbW8VzBFcJh9I11yHWGelPhL8d
55ZIe6kKVMZH0gz9nW3nHHggKK4wZ6J1o0V+pV26eKj1mLxaSdTumrKL74IiV9eBe8SJ/T2ys6kz
StUYzjgiWKtHvkF3gmn62yJ1vCu1SpR60pn6DLFseq0qJGyaJsI76kanXVK7/k+mnOTdxnL8e6Cv
Gv6OVnRRWwWzkg2cJSNyRN40d++tqfE+XJ3x3rfTlGzMpAJKWeH5HHzKDF5UlM8CqRZhmN4P83Fy
moISFMc6IgmH70aQZLfI8sd9pRP1NrvUCRTgkICAWCWuBrs9J2LwDk2x+KzsOZrQlntj1QmUREPx
hQtHJN85blVI3ll311dSn6bSqoi1zpz4lO8+CCpRSd9Ie0OMY8QpX1Qg0ab29xCPyXmwu+R7oGF7
O6YaG5DtAKPhcqJ4tDcBjIbZSpitO54qXzkxWv4NUxILCBaEXJQPnzIL1I9W6SOXvfHQDA5MW3YS
33jSyUdSMXIMFfBOnH18/jhNfYNOJ8gKn35d9vs4WOprGr/codG1Jx/laM1TlRU1H8pLQ+plXbS4
GlN3hBRGSOWDm3v8O8DU+GJifo33Ig+cE/FLb1pRqDmsl0hSgJ8vj56jZGCB30oRHCxvtDeTx99o
ebbPZnAY98zj5WU0ydqMeh6YTzuXXI3rlUw/zlFMqTY5tGaABeHgPck6YYlH0iyi/+SzMQP7VyXd
9jB20oLGpeJnqUom/bFx0ClTdJi6jPGaVVHPD7Szxwev9Nyf0a4nvaGXPd8P4zQwJIQnHvIm23Mz
vCoMj3+EX6OCgG6AeyMGwkV1DbCHW9ncgkn3+/hHgXU8WGXv70zsz2xhguIgabFeO3xuuE3jtjrV
fCq53XR5etTLHIVwMp0cXfffYWCGL/Q/QOOxA/Z0o+fXP9qevZ0TY0wzR81PwJjk45xRcxubiwqs
R339m5XHcopsM9hTecPm2HGnu9LG7Mjiyvwy3Np473MKKsnFD9e5M5PXKhrGt7JNyY9oA9/GQkeo
jgPFNtuhVePWDXKLBIEdbLwaUzLZGopJathkWN/LrcM5qda6qKwvi0sUvCrAOwn6UrT6G2vrQNMM
Eh26MNCHvLLaPwn8sEeMzTwq8xLmU14J3CZy6LamIfFqdQAEunos1kgoYl/EUXNs8GlvqsYsEbLm
35oNP/HzAr/mkA9sdLrC5d7nS4vNqp1nzx2r0AzizrTEBAuWxHlrA16p2fzg5ORadGc4XXaYUmHf
6WEZnNN0OGURBN6ktShzoteI5wNttq+zB32OjreRpRX3oxtXiosPLe5LBem4yzOlt/R7xs+qxZW8
rTyW7aOFlTGx6u4OwhcpPXxkm77gI9KALXyisO/NzbhAtjozT15gxKdS6eYFfOVIZCO3b3QV+adC
2wtsth13STLFt79Zbc8Qbnvq0MwyXVu1CHaV40G3dJGnVIXJN5EvnFAs5Nsl59BiRqBTxZmZLUTd
fkc0CG0ywK8JkIp8noAe8nbzPFN/8Hwotgwq866sJmvTwZ2oVn9TOGrGBWy0Jw+d7JOYmt6sYbj9
W9vELiVtWXwY8dk9JCGWYgEGayvtZNgrBpF9R1ho9b8B6H+UaZBY/u8D0B946T6/ht//uUyD3/JP
TL2By4yqCoueCp+88j8x9c7fTZ6TRuAE0uV5aVBh+Q9MvXT+7hqBGwQmFHDX453yH5h68PY2o7Dh
g1Lm/zZM638SgPat/1qm4RG89owASRIzq+lL/qp/jUDXPu3UrAmxFpau0x2msuMt+hRVBRiIC6JX
IvaxVom8JCHWuhoN/+wGUj+PRRmsmhDPiEX4ewenuVznoRrKYzDCg1dVB/QLwxy2bYOwq+e/wg/H
XmWO+6ZSw75mw4S8BjPPZyO6zoWezzxOetTmJQAbON8QyviUVc2zVw7Eh7vxl2EMHuEKIxY3P4nK
ZkVX89ivKnsqvi2jy44cj0v5UVet7XgujnxqkkPFv/JU2X7Ubbnf+GezFC4NE9AgirA017B1ypVL
jHCVGRLGlV292bL96pz4bLk56EdcGn3nM7n6aQiEhVYy3w57pIrpoUvkLqDC2dP+fW3h/GZNysd2
imC54K4FPDPHZDv/MGJOPEojuCOEpEK5tynUO0JebFqE8dS9U510PuueCjNgueV6NOynoqYyDabp
sG+diB43Du5tkS8ZHIZcuhUl9egO9jENNGenB0jkw1+oSEbK3Tj337nfDphkcEfXU4QtL0+gWOBH
31AR3m0NeogJPIQvHaSPtctcVUE0dhiRyxiWSdwgg7bVEZLbeJT49K6U91Ef0vTlWQjHXXcLqFVa
LXlSQblPXUTyuedCXq6qvmi/NbHG3aAa+YaabJ8nN7Y+AABi+Ep0fiBF1B99vI+8gIoCNFctq/uK
SxVxx9AlYW6bG0TeO9wmZIzTfB7xOmpgJ7GqV8YwTAc6ByquJQmGODgPgMycqp+f8aZo/Btlc5pY
qd1yPxYHj1sXT316MSviZmd/Kbc0UHpI1nb8DF2TehWnybzv0h/LN1Z79HWzQ1nP1WgebY6L56T3
OExYkK5Sl847km4lfgJTnynBkkeoJyQy+K7vfQU1iFR7RAdV1ZIMGWVKvj6W9t1QGoT3EvbMqHYN
WkI2kRwMdVZ+TsPQ7yeH/T6wd4BA5gy0wqp98iRWAmlkCDQjQhDSC63b+WjG9cD72scoR0ozQHKA
OUL32wohx/qOe/EFEWbvFRPwLS4y4lfAzoeEbzACGCiDz5Is3IuwY/uJN87MO8Vjje2k4w0DloMz
v8ST5LXNN3Vs4mRQofqoU0wA3N5fi9z29tx4uhXNLM3agOKIq76P74Ya1zugIWtHt6jcshzTOycy
xHaEVocpzmjifJVasfeHKElNMKiwz14y3aIck4RJjd+NdPu+X5hA5Jz2Oi8PjXDy+1G7p6rN2WnY
xoEIf/HkzWYFlzVmGek+JUHxWZoLh73W+LsxHHLNWX5gPfnOQFzmMnpcdoKzEzmrLrH1Pq6J8hKO
SJ+4z3pEiZW897V842Lr0pcuCe8VRndgID3gFflMofruzKKU93ijrHUi5m9Li/6Lq/51oUSXixGO
ncaGsuMN9bpI3vNLHjT0CqY3NO/PwYzept57CUFhNoAGd37LhdEjGNC4zdb1DAi7+g+sCCKxhvOG
vPbtmQSpFvvedswigF/11Yc3/KFwfZIzzJhCzDH+HbrVYxB79w2c0nM2itdSyR1JlHJdZPGmcdUZ
lP7RjcWb6AfvwbTFtFWqhtpMvA/nemWRfiirGDG/PlkVpvaiME6UmhJZIeVN1HzfNz1xcKvaCRUt
pZsWjwsPC3FTkWhvyYplycSj0ZOzeh5rBHBmwGwnmOotO6R3GOXLz/j5xQNEq6oI7qPWFouAVUAN
pUFi8vA02xIxtCDFBpTK3/r5j22l1c6q2e3wzLj4E1nIUATZaXJL85Tb5n2AyXZVCTy8fYVzQ2fO
nQcBctXO2Tem199qFntH4LwFsQHjrD4pgHNMltx48Kt9R21ymuvo2e+Lg2vA5YrtcYt562LhtsQv
zJnSau93GMKnywr3Fg/DM27188gnY+X1JjWfgs8T8e1r3nuku2JpIpKbt8FklxYMD5l0gz9phCkB
1ybLwxazUqnFfYJFChsAMX2PP2BH/IygiFXuPUXYIZpbuIA23gLbQc+lm9PYmLN3hlLeAyOcX4zc
q1Y6wcZH0XnOodU2T3GtOzDX8weW+X4bJn7228+a7DEQvGiW5veuzRIxCLtvu5dmXn/7OhhXioDw
CnSV/pmbft7QpdzuA1PU+9ITvkcsHr0Swalug1vnubzB5xl7X2y3wbAzcSPfl9OyAwxpjZTrGkTq
F4k59VTV/O9GG0XWrf2468EuTSBDawAeXRxSw9uxCIlaGvM6aGnIF0ZxMrMmXAdN3W/zPlkr20zZ
Cyus63MoNmnA3OI6QDR5sR0y5eRcaanYi6Ke15jD0507wTqS7Th+1kZOSxfTAes3TeMoAaYaN4hL
tQYpfpYQbMlV04/P5OaT4KQQlvA/5m6Lpc0dO0yxY4Lq2VPrCkGwWg+DzHcoiNRdhuoQMXmprvx0
unhLkSChrXLDybKmN+rdqBfnEFmv9ZTar2PStUd+MA9G46BKscAoDaD9RM8HlW5DIE2hnW6CDNhp
rDgB1tVIKYyt5NnIpq+qn8jLBu0mHI1blUA/jSv3QUo1kCjjZG3ZDZOKqvkea2JqYZr/8Rkx117J
TtCVBSAHeJ14euaAmttpGDd1ln0maAYURZLrtXGTcRnaAqVkZ16Yz7pYPpuutWgbZbZzBvE1lfhd
3bKBABNYbyXdAGTRyP5RBMvwZw1EPkr3RdXThXaB9hCgsWDLxNmcCXCboUGcBUcELgf6h4gbTkhl
ztQfYWFa0PKM3lsbTkgI346GS4ph/iz9IT2AqEbsZgFC+L54h6MB/dAbXGGswhJpuRrakCHZD+9t
nWUbH73m14Ad9dz3QfvUe86HF9cYQArU3olNFqUTO5IJ1Rb5bEMNan/kGuaih0lK4RK7JZuridSV
cbCTutw3mIlk629sd3xNp7DeZUMabXVEg6ciHkT/+psD65UgzZQ85xi2SK0aIW8BYte4PTkEnVp9
dXWoTlNeY9xzPQJuNYU/nzWE+hbTFJcbKF0cbNVCxYIpTBKqZwtPWzucsbUAScUPoCw7eFURr8c2
+as0yRyYfTkOsP/VN1lzm86XXTKnjW1Xsz6XLRuGjUXoTPcrNdUZbBTAbfAxrLQc/d0w0iKwM6Pu
jdwqe3qB9Ru4aIzgePH/Kn7qASyRrV76oIxkqYaC5dzoHaAJlT2IiFD5R2MZ47F2AgpWNxB4PP9l
NEgArq2Wbp97WRkGPVQUHnu/Kwwz+BmxutCdGWTe0O5Bzw0/ZRt5vQBqOmfTfT74Tfnm8uLSAB1Z
GKjoqls2Uxg9F4D03MYnUkUktS1+Kgt/DmZX8Re+q2p9dPJROBQvz38hvkBwz+ql4lp7qtxuXKeC
Jxlcz5qNZLiQwmajsU/ZQg+DDA5IjMgLUDEsBwDG3IU1pgxKzmHu/QUhG/4CkumFTdaoCscstNxt
Q362IywHUv3UKWLxk7Z8fTCJEoKFzYOc77WzFQd+WQj8BvwVnz7b9BrwJllVtiy1m9LtOlfki6o+
D817RJ+emcQUuj9aMOmeKXNxvoIkx9U/udLHsD27wKcsihOwW8wT4iWc5pmaENemwuMh6ZMopnQ2
WRoQxgpYYhsXzUcxYafclK5PCQCYYYhDU6cq822IGgH6F4cnTyKYH92G1I2dNquhSUAjRqMexSMO
Oexh0J/85rFQbh28Sq/hUY0jRxk7A39bu+fTZdAA6nZDB/0FrS5bUTGWtqvKBOi+KXpdIwqVZVFw
+LeRe/FkTgfCKFl9bCO5IFlMQVnUKuOZoX9YOw+cOzH6LEfS6NylVjhz4pE2/mW3hfxsfR68KzrE
9YuvsinfcCjkwyHUIVsmSWsr6R8F7sWZm4May1n++FbvN3tjnAw4NK2UDCsYArvpPPdJeS9ajr89
Hy53OJWInJh8fXJrNjFVfBANkJRNkoxj8WDUA4VLRT4xGMOB4jLQVixmoAwuHGLpbEGNv5VEOx6V
keZHVh7Oul1OG034jjm2R3PrxxQCfRJgKYMn2FjLYGea3dGfLePBq430wTQ0AJoh4HXVuL+9VWuY
9XswhPIhGG37PYzjFyYm3p+yQ/IVcRFiq+Rjt+5kkL8NvZssRpwuXtgBGZcr3RIUgvJIKxNMnM8g
c+1pY/g0JDaV18KT5xb+yqzXio2Gs9WciGR6Bl4tfPGIeu4qMpt6B5q9NQnHyBB3ZqixT0NZKGio
dvv0mUqIzzY13YsqA72rQ7zqnW/fzyYOrowXoIiIISfegJc8uRFHXcNKrpJT7hEwYIqV2VVHyZ+p
ThrMTGUaEKeMI3IbrtzWtc0inULmcgUyrsPrzyrjf3Wqf9epPEhz/71O9UQAN/4/T93Pfyb1mcvv
+nepyvk79u8g8OzAcxwfXuo/pSrr77ZjoxM5UGkozoG59w+pSpqoWK4VYLKyfMtwXP449kVt/G//
l9/k+/g7eL/ZlCDy3/+JUAXKB0HsX8h5nolVybMRxUD1WTb5P6S0f1WqCunTczN2v3rL8rbmbPv6
TpBMOBO3mrGnEHmeY5LqKzsYOGrj5og51txPcelwxMNFFdABTgAhaMKaKCiuGtBLSOKHOnbUXtnp
Z97hyoxqG8ts8ZAEM7c0rDTbpCdwpeg7PnSeg2fVEb8jL8CcZc+4tqLx2ub5jQvzMVXikXUrNz28
Tlw82j+mjl4zVV0j6d0DTbVXGB2pFhDhkaZWh6YKJ32w6Hl9bguqDmCBWONZuKhtkHvSKdtlLcGK
BZ3AAVbRLoIyliQfLPuSc9/WkjvEpE5e1zrPfMbVasydd8fOuM+hNJTfBXwRj/1A3N9FrSkPuUCR
QbjvGKLxsBEwdiew7AQIVwNQwYOfan2MtVncWGM5n5YKcVc5uj3kQZ+8mF2zSEB4yO9zDpVmw6sU
sxWgVxXC1J8kn9xTPhvme7kAimQ6R/VuGIqrs0gMXeu9dUUwru2sUHeqVvflHJ9mO3wIx+Tex73w
/9g7s93IkTRLv0qj7plDmpE0stHVQPvuLrn2LXRDKCQF982429PP55nZmKwGpmfqdjB5lQFFKBRO
0mh2/nO+k8TeUenhwcoo+6gZXJBMj0Bh4Va4D9T4WIXJ41zR892my1pWnIdUOT3ZIz1S6ZRb2Ab9
wcP6FC5fKJNnlMiZ+EbaA5TIghihQ4oVxWDWYzYM3/ivqFucwpOA1YALsLaaBqe4P5La+9Wn/Jt+
zNWoKjqF8b5YJoSYbDkEJzgmXLSPkvgC5C281PZQb1EwcD12tKB07sEa83ljJuXNP2qOKYvCnl2U
Tn2oaDwL1lOU5u0b7Ef7tRhrL6XhoSynB/KRU/wyOdlMAmEOQmPtgCt5+a7LnCJa65KE93paOgMx
KcF4swsTTAAQLYZRceNYHRutrQrhHa8qo4Lvyc94kUayBDiue8vH8TgPTwwIgqeRVs/VaKC0LORF
ElozePEo7KfrEcfkYzAP4ZYDaXwVeFV9axmdN5w6CrUXeHDw+tHmfgOGxzoRy29ebExkbwxz4/tS
YTjYUHrLXeOaC2TEGBJhm2haUrJh5dhHeLJ+J+17l34j0r3LpSyrBHmzcpp6BIrSJhZLf5Prjdek
ZUOfmuSec7npCYss9QGTjLWZXF7RK0p6R/QE6WKhclKH0hRiCHhxS+IAKjEnzgvDOS1b/y63ZkjN
k5qKx4jihm2Oew6baVNiXcgdZzc5fXgMnNbqGAdFDB1zhjgXiHrdvdPmAVQB7MX74BbeFdNGm91M
mJAmLfJjwMFrsP3w3AsP0jmRIqLUpb6nHMr5hi/e3vM5u7t4HjVKwEAJlg17A92Sy3aH7pxtyQAC
xAQ6SDuArEW1HzHu3yxE+44h8s1p9u36beT0uK/TOPwFk5yMG1iIz4QI5W7GHLtdJi7QBOtkw0+I
3Qihmym1W++UJ5J9ZdjHUC4q94kygHnAMPEzF8mwgTju3sEx89fWiN/UK8b+upmGdhMlxXhD8XwE
m6sxjx1QAw7UBBoIIXpYFD0Yy5xgyIUuDlVJlLasl5IzIvwQ92APOUwUSQkKBWMGD5GcN6lqnE2Y
2JTAVHgGVmPAqbisSWn01YTS28FBY+gN04Pq6p8tzOzbhuVpw2EMkXqMwWM43JXrzg0QRA0zQc4w
sfJPbTbJuzBj1ZpsojJDBK2I7hw6guAjygEsvblkZHvRv0Sh7a0TJzoSu1tNlhNvTeB8kragB0t4
2Z7qxD0LXvol8vx7aa3kUFnQIEjrEZYuWECb4oquxl0nSBBNVm1v+6WiTCqFft55bM4GmH1n3w32
U49tOszx3kS1R3NKnYsT3YQ+pVZVN23CGYujm0Z8AhhkgOek6wV3+bbMiqtMGLze6hexdfDicWaD
hSgJxzgu0QrhbqbElQ/D4DhbLLm/AkQ4Edt3wiHSVnt2cYVK02zsiK+XWl9GDeGwqZpM7A18UjN5
+bYIPFAlDHFXlolgmI/dPUYCZH8wBquFusRnnq4VVwmNpe3OdW5NiAeY8XsW3ERC+Yta82EFYGsi
vUQb5l4/52x6rfL5fTH+kx8lR5VP3mYhibrywgvHXzrzCYnNvaKMZtlGHEe3Wdx+8U6+y40n6Myc
mrXQ4i41zXDwhAA4ogL6I6NiFygUXS9opq3fAbStK6x6i+uuy0rdV7l11sL9rDVYFHIL27iaLSIK
o17loj4mLiT6uKzWjN6eoyqfVpCYPqep/46XriZnzieUcywNC3tnTUDJTXm24aLw0mfhLzUmzoV9
/DZaeOMG3pkzwsYZPXtNNdJnF/Jim5M7uubemUydbKDrm3nkjmuK4cFY9F1CY8fDh9cWH/IuimZm
MMT/5+Yzkt2X20br1Ovem7kuN0sY75wGs7vjuS4WXutuhLgle9pI8YxMV5iPyMuTV16pqEKsTtJ1
X+SYSwCRtVi2mKNVTx1X5wjVtNrYSYGVNX92jHJXGZn7RNEJgcm72/Ymtpj2xDPmKKYtfmbV66xi
BjdVtsSeVfjWyuuyCo+uRlgtWF5aAWAPHRFAFzYk2QRPcxPylijMoQ9ZTHEwr2MsQUrlX+jTRxrj
93L0l+2kKQiEP0EXpxYvaR7ccTEuzjpSga5/CK02WtlSbEeyUZNGQ4DS+JWn/o8CZH6eBo9iAC2G
fBni/UBhRlNa3uKsv/X75uKZBELWcZoRhaaAaPbaA1BdmHBh3+0rYDKvhlHPeWKxv5GckF6yGs+i
P1qcRNL5FxLguEka8qV5Hct1tzQ7CoUFr1CYb6T7g82SxfmT47bDlgfb3ZhBP+V2dI2jb970k0Nc
Le3BIEIQXKWeHo78+2ktDADs9UNx8u18NzB0IeFk5FqqsD7rEDw8dXB4ZJ063zkDKwvJTE7EIrqU
wEXVu2OWaEuR6ClzxAcRpHTflXV17PKACV8HoixYcnR4qckVRs43YzqUSMY2i4wWYgLq12hjirAv
peJ2RyyljmzUqFE4T1U18vyO6j0NCNNHRRhcB5SwbDT4vNXYNcCB2gA4dDxYNzYNpufBDs9BDuwM
Vv3d6Ij5HOEYvcoWxXFeOXcOALLtnI7ZDzu15c6ZWsD6RY7tEIvkDWdzgj7V/ErzFPJWQBS6Yz3O
0E6m8BcjE6pCK2UjJ5Y67t6sJfVIPBPJxrV+QSUBizPC/Oj4zDAJgn4jHDzj+E1yiIfFvDwpQGcN
L3rR3w3JkMRsxqWlL7tTJI6K9+W6x/OxCso0/Ox6CbPNOPZxGHIM9CL9tH3XfswIvXayIN7sWOrO
tC3LYKRPcRk5vHbwjBY+OTXSAjS41Zxd5+ZWjx5Gnuxik53jbJ0VeHJrI8/+1B6Gbjybrj1atrmW
87hLqwvbq2hoRGJmgqebhVXVF59HlZHJYisD1hZtV/fundDLgVjPHazr/KAVnXYJQZEjRYPFMb3E
p6syg2pPfXk1/mRX65BWXc4+093nWcH5Exr90/UYEiKUMbxMlzF/b+kuSVce0WrmOGwZBxrlVvMY
nXBumVPY4yLy7WHiTeMCQxvwkkGMg8oUrIvIy2x329oibX65qXDMvuyNmt/GIBcK9qdNewGgEFp4
Hi1iQil8nyV1EPjL2R9ovYqVfY5143lfJQdD70RPN0I5m7oJ/RHOSTTTekUZEcujIA0RA2MUdozj
shw7d0c3XnYVCT1/REYpTmJMe2uQ5JiqUW7HwIUPJhN/O8/+dMa3aDHGbYqUzXXmObmi0napun5n
Mdeac9b2LvB/+oNFbafvl6nKd1GT5hN2KnYZHP1E7FH6qxbZlt7ZjnVbHmvFva82SmsmlC7debzS
rUbKXtzkLl/irmCJC+lWKAMK+3y5xI7YNnQjuQdDCgiSwkR6b7iBsKHwFuXUTygWqAEsggnKMAnX
CXXFtr5WuJGn8wKaqSBilXWd/xSXjgu4iBJB/9uZvPlnqcr8nFVpBSPA93PeTkshSng7vHnmnfS8
rNyooAhe+iGNmM1HebvnvTK/LVUafDh9q6NX7Q7jdlH0uneZ+ZUakiSjYVvcd87z4FLDKM3b7HJj
dzSvA/MYDomOKX9Ruj1hK6Nsi0mu3/KOZDfUgORSJznlwcoqGU+3Vf82CKbpOuctMuugXzfduEl1
7eDuUq/AqBl7aG+6mUdTE8jD5gn0LNjawo72C2m/zTDCm+y98FXRTZfkjtxSG/Ft/L47ViGbRgBl
fXmonfYMJYZKSQPXxuP0TpyQ1xWokNu8MLATHBPvs1C9cInvaKbg9ZUcZG9na5X5zwluwh2Ugg89
z1e06mYrljIavdw3+nwa4K5Tuwkk7SEChDuu9OA1dxgpAXNm7MGTX3CugNjCZF7n/hbj/9ob3Xvk
yVMh2zdjgQMtuzepsoegMNet9O/cS4KBIcNWC5TDwKQvRd0w5gui6FSPkB8JAS1rT5W/jHTuM4sN
RFIwUihQDBgu2AydG2+FpPyMrXo4jalE721ZhknGkpjJ1gnMZWY9IcmiTK9xDWUHnNflYWzY4o8L
OM98wRSdK1JoJa98GogYp3fzB8dOe0sa+5ddlDvCZEB/FPHwwQ7Yo14SlSQUhmOVckB0EXtD/Hes
MOqoY6CrIHJND9m1SqNHnLrpeiRzeTXJ/JhmrUZrTe482HP7AgwpmfwO6Awj2SGjZrRJwoe00LtQ
xckGdfdd995HYrfzgTA7/STMhjkV0SAp/Y7jT35OkN43eQIuEB/Gu614fy12XtFCElBJWafZPTAa
tgB545BfSdJtUsqfYdU+uNA9pI2Azs9VbV0+sy1zaiw9lpccSbbRG4cvZG1X80+7WT6UbOSmUtgI
rFKJbWvEVhpYjATibzKjD/7oXxlJqWZMCHqvSJBfLzX+xiBZPDYgnXXimXxNLIFZ53KKTOahJ+6Q
csoBK7C2kvgXts9hJ+f6FTTUzTTwzbVRZl25RXKVSU3pEiMC0hX70hvnTaE03IDFZr9gXZoz21/j
2DK5Bo/DD0iI3+m+0NixVhdszBbuEyckIgA79iOz0jfM5OW6zNRVmA0GpR9DhIXnKk2yM9fozb50
MlP8G2wG7VN5MAIjqMAe7Sc9VRtZFmvDj7z1QErCpLE4DgHBa+dAgZYhPp1ast/OOMGQjuz8sLSK
HrsUSBdgBPf3JM0BpaiDluHc1pozb2OKdBO5oMDHliwnRlvbNj7ZXTrQnIbwTOr2Z1eGdMpSIrDK
KCtA0xl/CDoQhaLsdZKEJ0wO3xnu9b2Pw3EL9qzdDE56Kob5Zq5oDxtH8+GyJgHbW/qtpmt7C4aB
Q7IiCS8XEhPAW+1LcnXVl3TEjEwZ96p2s3MVYNeOaYbgkd8XHMgSz7xaUlwt2BjQ0LH0VwoGQI0z
hTwCHQJ8iiPh8eU8NnIXhKTmkYZIMsyrUFB9OhOXtYgDRnnlr6cgubat6Qcpg1cLTSgKKOFjAnwT
ptjBL8Rktnd7xEGieRadHWVya9cJbpDu1I+U616OguB6ooWXPffvTguonaCiyZKaGFB/JziUdj8z
ttEuMuHacD4pO7LwxtvmKAmbMM0PYVfd0u+5rUKCpiN9ISSnBoZk1GzXXx4x5M1CnEVmv/AFb4eB
QQylUqvMYrDj9ntVsrkPmhPWCRKozVtQl+epsQ75VF9VenkO4BxFqn/0AJmv8nj6kXvRo2CCQo8U
ss6Cn+ViBS/omM7YTM67xp7piWrSLRKKsxkLPzoXsrxtSJBCvcPzFbnRC0bEo3F7gfe9wnFG696a
9q975v+Gs1SU3CYeX4y74bad2a/LCjdOHKKOVo+6AwFVmUfblVd9gZe5hgoA6OHc0HlhMHfUjEEa
Ni8kVQ1zO/oFW3pZ3Ia9a2S6254dMjSV3sEeyHJTJK8jbJsQFlk1swx0XXCmCh4topP5KiNZcBQp
5IJQBKu2q7aGxnoSx3yIdC2r8hyCkg9jj8O/yV5YRTfBbOO2mb4SYi/M/C0Y32N860b6c9T+NnAG
ukKLL1zGT0tPWpYZqLxPBRgchxOy5U7XOLPGU6rsV75tzBIUrJuo2SQ2fM+S5gQc2e2nBGrFPP2U
gHnDaan3WN6XdeaCgQ28TQZeG08jEo0z6Q/4ieDaTXk1Fvpd5ma6wht6W3s81S7b133o0TA400yl
5MKGytvRFfARVvoJuMJVI5Jt2XKylKTDqBhpd8w4nymyKiFiQMW3KmwkA1zhNKhul8Ddhp1wOBzj
ElX9N/ZxizMWddbKjzmijTgB02vj1PjKsIf0E0LGGNyIfmRqRi/Pg4+xUE/rIVl82EVZLMoDs162
ZL3fqRvZzM74RA0IBKoqGezuwMPugUcxS2F/TgmC01zm5lJ9wsEKCTJjd5bQnNDQLxpuJbvo8W5o
W2dfeWW/cxu3p1bLQGElmnQZXfmznUz3VmGn+tiOtqLVm3MDzUFz7emvQQQ1tji38QlcB+50l0/s
wTYyMTml04XEKIhUHobjdSj80nmvrfwnegRd1y6Aff0897bGxMKXOjJAcmI+GLiuGvaaZrnkW8+A
5YU7cZ9HQ6vLRzlHbB5lzygiH5b2COUm8g7QzpFxyAyJxyLr9GkeaSNgH+ote68PbGrh7NbfB1mP
H5TdI82iHNGm/MoP6lx/xLkhsFXjWNC7DHj0TBQuYJPgs7jd1EURQ79axqe66TkQVxprD1oE8NUV
Sp65EDgs/z6u6fs5oIG7IQU2U4GUWmlZolA4rMgA8fseUyxmSIkbFbcvhS+13Sjkfd9JbnGuJT2v
3xI2FppJdzUKolk3heu6+kZXtiBFMLl9vOGypxVMqwRSYTGUDl7CeKjUalnauIQWKYEl97Bqpit1
4XGpCrigs7Q7qxrBkrWkc441AetjMGfwn2nbCMeVAIBKno/e3JLZAUz6BdNOKzwr3zKlArkYKGGV
hylOY7OFU9mydRkUsHJPeQMZHE7xsPmGi6gVVHD1Um7FdRJVQfQ8e13w3o3s/NYLgEu5TZokwbGD
AxqeXtWrjU/FMZFnk+8KR9NvpDiuiNtxcBhG9DMBhgDD/wYI9rK3S9435WiVG0wXOe4RU22isi8v
HPbmIGRwTryOy+bwNJ4csYyU73X5fsgMk9cxrk+k0s8wJPNTtDDO8k3xAekd3G1n+oPFgerKKWp7
k+XqtZ0uj6NF0fwIkXpFym+EVspiXauJVTaZ94CJ5N4HVrOzMoIzkDVBbcbDjvyvzwZVEWuRuLoi
YrDroWzvbYsoVxXCW3Nkh6kl5RBVKdKBVVsNLKBxz4hFg7HtLlDTxfvSlhnAp5oY46uXWSegSdxN
lDrdF8ykgWfZ+iCn7hmhuDvOdmsF68u888hJgTl+C7I+yizvUfhOd1Wmc0hqVV+Emmo8Ra5JD6Gg
idCaDkLnaFB0/KxsZ3io44Dim/40asIik1VQluNdgrNpxLZSzi/J6H5LkUw3fRLTECXT6VxYzkuY
1svWHWdy8n4R7RmTDjCnwgCUQVutk5wO5ihnntPodk+kdEXB97AOp2pkKZ/a7VC7YPWCCu2mH1fW
MAUHwWlgjfs03KV5WT3gvezvB9tcQRFBTOjZwAwxaNHILC0tFVYBJGqKDwyhupeOgvVdLOLkKYx6
MO7eZzABzqlcojUojrtiHt09Bin3M2J2sM1SbJYYZ4O1gitEYhLtmECAxNMyLkdJB/2xHOmw9is3
vcP6RjX3QhaXIq7XobCjQ8oNz5iQopCwjSwin2AswwyChS/odGkUfIEBT9QaFLfEi2bxDk9UCGAz
h4mBuEmnFxf9hvGaTapUOsBLSGYiPlm7C0t67zrKAjBM+pE1ZqWTCApoXqVXTQ6Sd+iZrOQWM1eL
njNOQYU6g6uFvIk5h7Mz7bEdkcaiu2AeZ3/t5RMrR1C2+tR2rDBjRBrZHsTt0JkCNFTCpkA2PwKs
oiA2Aoz8jOfkxD6wC3TK1s+e9lpcAALK1Jg5BXmHBZL1qhhtjsOzHew95jobh/Ptrs1zSc0XXZhM
1cLyS8nqBQI0+IvFShiiqQe7HdzdHLi4y+b4vcUpdQVw/NIWJMC+teWyVR1bhzpJXqI8JjZZk0vM
aFdZwUvECsTRr7xMN5iGMvm8Cy8oV5/W1ie25/IJmcnfcliMn0df3s95+kkLJTDHsXounfwZU2V1
qIvqPYfDci/hlVPLU0yXM7QhZi7gJ5KDXOU9ZIHEHlKeEiyHJVScTZin0+qSNOGcWzQPtItkm6ns
9AY/T14AWV6iVxNzZi3hnJ/wi+h7QO5mNcZZ/lExXl7VIg97aM1mvKTaxKqfvXyPL2btTKYlQdzM
OwJ5DhSYiRUqZ7exAt/8QSbroSh6RCTb8o5Z40WXjPJXWdjDdUNlfT4xkKAFp77rIMyu4WHvZmSB
0nX0S6y7cmNiTaOuasD7Tl3HClJBtq/omgocOA3pMhEF8WckGw5Sqnb8bdSzbZ2weh871wHFNVLF
N3f3jg6Jj7YgXZHMOKDmrwhJ8ZWnCRQWUy9pv4CYmNRtuhbz+ED69VTxIt14bD0Onrskm1bocusT
IF7hq/tVxMz4raF+1os5N0F6HKrkG3IKAbKmhf3YZfVbimMPXFlErV47lHs/C/ybtl/uus5irBLn
cl5DbXhyI7c/uq7t3dUDjS7s4PDEhni7V6E3YCSoJnmMZISPGFIfXOtzGVvqWHg8/KJJ/TfGivw1
diauEqu81hdwABCI/joaQZPNdcKw2SdsSSroA+MCxQrKn+Whby1zjd4Z3lmWY0P2gCftO5Zz7lq6
gLGRZ8d5yOhIzwMIGEGMkpyOYnrhwQN1Ry7+8hi/Nc10Z9fVC3fDM8hown+L+pkhqm/wE2FF1pJt
rabNd4jLD7E41gNqfUkJDjAgVh4+BFZ/vbTBHu5JdOh5LW8peLKPFtlNQkph+bNfkhdySt9G+SDD
1fJqy3zCG+tIQb2OPx+SoKMfNwAYB2PuWXtEHAhHHEATBHvK8fwjCSPayOkug9/WDQ3lQOMXwZue
0DMSzcxPehZpYlATASdy5I9eWD8zZ5WSlAI4ncV7tnXzDlrAj9Q3oG5GLz02PNUHL6kqpoXUqe/Z
Sqgjjw8FBSSgD0b47XUl84+xLOKjXQXts0X6M7hw1puc9jHakQihd1WznwX1KsYt3d3EpILeZ1+y
vIEazkL+Ybknl22NoXmrVEp8M7KuFIjHJFDwD+unLhieS+HmWwg5wRkXb3aGnnbFw5KesCdL9mGA
5IJs+HRhYNHfh2m1mxmLmV4jI3cMP3H4xlciCDakAz506EyPYAOvp5QpTmhvC0nxlKR+BfeEs/HC
NMDANnlXUYTUKiyOsTwxzoCLLvI8kKbsytbEhRhqZfn2/zvE/nCIefK/dYjh/P+Xpw9alP4aZfz9
z/zpD3N/s3Fz+TZkOPG7Qew//WFS/ub4/MewNxBSuIIa1T+jjKQVbf5jmVTSDXwp/leSUTi/8X34
ogwcbF1KqH/KH4YH7R/cYZKNtUCADG3p8R3VJef4l15Vl1tTBIaYShGOnfMz4vewSTX0Wv/CVgXN
DkNiCI0EDSHvGRR6MWp3vMIW6jNG7bjxaNkutec9/PP3023zXT32+vu7P380//Y/Pud//SSsq1Pg
zP/+j7/s/vh1/F1vPvqPf/gFndtpv9wP33p5+O5obvj3f+Mb/fk7/2+/+C/fv3+Xp6X5/vvfPimM
7y/fLca99terjtcOjx2zuQDAv4N/IKCb93/vLfyPn8t3+n/883/cRYLvNH13/d//JtRvgRQYBIUt
hLI9m1vjz7vGsf+4oQCIcaM5tocV8E9XYfibdCWeVMcXoS8DX4l/6q75L55CyUCGYmLhceoNaABX
lB3/9a6ZYw+97VIIWM2Nz2a98CkGgxNqM7ubc7KzpCZ8Wm2A1QdPsuUARmtN2ejgocu9+NIlSxlv
o99r6Fc1ub8012qjC2XDz2ntxFWf/+/fTZ793647/1FBof3s08+Pv95Cv/+hP24ZJ+Cq/HHPWL//
/3/GpH37N4+bNMSr6juh417+nj9vE5Ts32zPcS4rglAeBtV/zn1qy9+7oOtiiRmwf/39b77jYYB1
iWWzv3Kpiw7/y63SMHQQTRbAIU+Gpei0KOFUwk8PnPIUS/qqaG3D9NNMZYnX7VejOrKtdxGDM+ve
h62fQ8yuS12iWkVtTpZtW5P1QJaXMNZQg4sgBEJzUkuGLfLGTpnGQUSNowTBjW1AL/e6GI07P3aY
dTNra6x2AL9ZSb8qkxsALQuHGBclNlgx7CO8oierd+lGmp353GCldOECobwcQIcu+svu+rHcLqUb
Lp+9O2JLiON+KXG7Gt1shzLWYt/g8ihrggM9qPl1H3UWfY8RdCL7sHguQgsIcPb22KBoKCE3NScc
EzhvcZDYkeBm6xePbX7T9FhHT11aMG9dYW9t689ulmX/ahAIHrh44aaeikEhaTiTSBCH63B6zTuw
rU4Qg/1OprDgmLCE7TZRWDXvw9FrnvkbkB/DtrmZrYSAts5kUnLAjKj7oaN3OWHwpZu3Cn18cNjY
x68ilG1/tZSJfwfzw8M5gxMoyq5dc6kDk34wvvUh5XzkTakY6nz3I+8hEU4pYUQ4JoCo1lZp1+F+
jonKDKHjvIzjqMlWKtcmvaQ5SC4HPiw2r3PPabey6T1a5yPQ42gaXcT8RNevEFWWTT8sFp11pmSL
FQ6UUViMgrodjUARe7e62kV1FyGMsEIth8zrerOfLYAC4pHTbpu/dMZY2a9uCGIqsUgLSTbfcapu
rQJrAmuPpdq1xiAhjviJh4wrLdELdYBy/tMe3HIf9A5zDVp8Dqj+MeKa2+JxuLQND4Q9eFsu1Nsm
WFs35Fes22Hy0k0n8P51y6XqcLHQYMIpp8WUidGKOVv5HkC63c21yNy1E0MZNi6axppDGRzOGecA
53swMRDdrAhNaJHHuRj0K5GDGrIrJ08qNVk0n8ugm+5Y/bH2eg3xUqPnccAKp/v5V+U0mFU8WU8j
qWGqSo0An0bGXXI5t5ZY2jraSoJtybZKuuXQUaoRbHo5QxlzZO9cO7q0tokpdXpm18w+0mcDYF9V
lGTLq1QrpHeMl7HF+CHpQnJauVUElGWWzCqrtU7H+sWvy2r8oFtZ7uhPNgccrl5yGixK2NeVmCLx
zRNcXuxo0ank0lk02dVud3AXQxMnsCh6tZjD6hcG+35yRwMqUT1Ut20HpWzXQcLDdtW44/fk1fIV
uk95EF5vvY34V6K1iAxvmnGsC2ynpngEIWXWEa96KlDx2+1qdHBuzgHvOfY85hjMTl2ufILWsxZD
xCAkRnuZV1ZLk8tmmlzv4tOacH5iL2OYZCDEXaCC9FIOAxUrZsIGNs6XKXg0MHU9u40TkxfDO5Ki
dxLl+fSl1K+FzIrmCr8Q1uIY8nG+WyyFXjokqYQ8Cpr/MF3S1EBuLRFdw6UpzphH0wdnYiTaIkY+
94uYXpd8CTd5idWOMSRthJJhFw6YGIxdtgbmGgAjR2XfOvixTgYe396Qq73DoiycfTx0PnDpICbs
aNFxtR4yK7gmN5CdBRvUfj1moT53Yzi+BhMBbpLKKNj9RiUjzTayZMjoY3K6UcT4QX5G/ryr8Vif
u6QL2g11E1W9HwX8mNWAm4K5t+H0Ggw6YCxZxDcBaaBik9eu2PWQc8Q7TKAx3Ho4SputU7N2rMfO
am6ZUzL8x2th8HvNzEEZmBGj8ngtMqobM3We2tF7iQKWb2yxZoQEvSwMTOZWdOfKcpCo8ZvP3g+h
6+zONDFWT0abDmaCenZIbRXMDclHgLyu/aW7znQEu5iS4V3RWVALbfxFDwkzj9vKiqOXKipb6xd5
uwBETlWTfl6YBfs0HIE83zK8R7sHKUzxBnQaj9hXjXwKr7YaaxO9dKVMAakuod3etT5LDE2Luqt3
0ySAUCiPsd1BVHAOQAV574bEV7Pm75jstQ1NIdyRym0PVTI3G4pSuHzoiwkxz9GixA9tUVIgIkY9
wzXyVPrg97PFJL6pcgJSVXqyiNeT6o9qNa8bO6rvfa/BAxVKl1Iem2RjHaAuYCDx3HuiwKzkQbPE
P5RXTc9tJAU1LhURku+uc7y3hHWpXXVitrnMRbEHXmAjIIRBuet4PPNtRr8MylzPTbLKGJjdNhBY
bapGqPqKB1w2vOHGKdyOQmHGZRZS0STSoqEfqEfukRlTnTAu7Lu+/tn63eWv6MuLKTDPkGpz3TiH
bqTNAZWYcdgq5GsNIlDlJYwVOcTzeu88tyOHSBVVWoZPIXIhbMqYrgOtmcAgTPfol1UXgNbkR9MR
mCxp06+klDfdBmkdMCIoLLL+M+xTfqKBNZ5Nbp8MDGjtS+dbIpkvXHiXGCjQ/QiYhFvBsH+nSrct
h7Wys9rZuTlg76DrZsFnZfnxMR7wwa6wW5f2z6l27JxScVzODb2HSUT/NMSNuxm1mahaF6vplj3T
wvKXFfvJ9Hxa0I3Z82Se9FA0EFQorxmwERunDK0abSlzDrLSKWP+MOezyXkRgoLD9Vs8h0UJRaC1
7KFb9xOEbjcjXrvzuGQ3AMCAOq4bvO78oyoYIZoURnV06O3BXaH4EPa8cqejRZy5JJ7julveSVym
sIDMRJOih008FwlDtNaPwv7YeAaWbuvN7mflGB0fCATpi/Kx9OPDkJdTcbbtML8jtEJvD4zTZj7g
sKVGvsZNcC8S4iZrbwhZuZ3KzV6ZF/bYxFzetM9RvthPdgPf7wKtCJ9tbbh7VVFUD0mSBu/o/9aP
DC9fc47G0dNwumOQLWiiEwC0LMPtZ0yeboUQ4107mZKXcT5Jim1UrtJX2ATxzzKNXB8W1VChh+dR
7F4PlhgIbRoLm9eotcd7qrUB5mEMkl98p5BpAJ2MD9hN23k/q5hdiWAo+YYR16aoM7cJ2W4YnVcF
nhHbzJuglwsAGdurtmlniEUnnpQ+fSYXwI8VmoyCLd5y782gMiLVBKms3WRbc/kwwpVBsi6DeXo0
Qk9fhv7gt8WpWCGrcaZKIHdaPK7qEl5caUTF+9FqJ2JeidPMz0vWR822o3eI27cxGe0tMvaLXTYh
z3KJiQRNhFAPmofq3liN+JgB4EQobpyEqa6rNdj5ICcjIq0hR50FYAiAcHCRbZWNORNUgTsyoU9Q
Q9jnZqo5aX+mDi4vg7C+0nYr4SlgUTM+2GXinFjeGjEReMz86X9ydGbLceNYEP0iRJAgAZKvtVep
tFuy5BeGrJYJ7hu4fv2cmpeJ6I72WKoiseTNPPlrwW6H+R19lt6uQuz6vh/xmlYmxMeBxM8RfLLh
K3Viwr1UMBHpq3HI/x/GKmtAjksgUw8LrXH0YPUGEgDov+6+LshYc9Yd4/7eun79NWBR4wzCr2+2
iyuTv2POkPaJdhYTX6xqqBsrbPzS8fSoY60ATHy1DEnXZFfSX7kXmsX8BTfn2uKM1yuL5DojxpKW
CNtIo7576q1dp/7GBujMHS1XtNeMmjjTEZ7HTHS/K/FrmiCc/saVUO5ljqQHN66tAKUO9Ri9WRNF
4jDC6r4qjlzQoBk0I7qugvmNO91SKcwRdbudqKoOmZncgv1JohAiSbemp4VJ2Hwp0mE6xp5qcLsH
cYkzDODT+mLnnslbJdbw3FaugynHx5Z589SRZm59Vny+jlFRJpG5iseCyfehHfG7EuzBmktphvoF
Y0G7G/zIyQOpMS/91PBtiA4Bxp/RQhsjn/IGl/0hCafWXIJKhn9LW0AKmhUGv6Ao8UK1nW3wUdUk
u7ZwX80fr6omQYF0glcyT7qgfwqxUP90XBHxqGA9vG9n7glnIoXBcOesIvmiosjgquv0c4kdJz1U
tW9G7BxTes+1s902/L9bhvW95LWA4ZCk52KFL3mVE+1pd0sG22839LX4D5vG4F3CIXHyv37RVeN/
DuV+ND81qOhErVFzfwM7Lv8u2bQAzBmLu7HzUkrzjOGgliR/g1y14Cf7Uv325hDkNslF8y6CVVPX
29Tlsx7T4J3f2emw5bIeAMCLWkZtZT+21F/kjI/auLZvo2Mllh8Fn2PPqgQwMBFd6d27kVDLAZd+
0b6TC+7TX/ngjWanEa3yl9lZyu5SOjql5LNOuPNtK3BIxRmJ3XHuJzzVw77BfDVQR9NyvoM9ZT68
rO6To08c+pdfrY6zb1xBNSzTvGx8gMgd/xkkH/J+HI202aYc1iU50nyq5p2og2z+mRzbqLdZ54Ru
4FG50EbUeIS5kLwMa+C8k2eVb+Woh3PpkGN595l87Dot7afH/hQ+Zx31mZsxVBPPtA6dHVTPlQM1
BPrshqxKcbFMbhKekwB84K3y1t+ChysfZ51QXNpV4ZEuGzgvvgmOHV2M9+6MOO7EufsunJK6CYk2
TiiyaqEtYt5C7xw5wu3wlkbDRnN9e9IrlJB9l66e3YRkfddjm4Ll3wMGZURIgtBJ9joLonvOusMn
x1B89YOmG81pl+UKwYLZdVWViqyXGoDuc3omeNeGnQ5AP97qGdgEeaOrCL/8b8OzUN03yuVKMfdc
eU9RuXK4CLUCoxGX/cI8EdCXHSYaURDqsmNc9fO5FGFOpkfeCt2T8nV2qth5yGaASbBy9OM84QH2
QeJygZgZDYpyId6uA6eMv0K8Clg3qqR/rDWdrmYI0+qian9+wLswD581Ru2LgiUDe2YJzF0YAu4d
qJr/j+aHINhbogkPReKPxzlKmmxbAFrot0RlMqojg3x9qWQUjnh00whqWjTb13zOoHhIIu7wY6oV
oJyl9u6/VWHjib1g1Je+w3W8bTDb4PVPg+hNE4F6HYhqMiHk9nIjvePqi3HzJcfBr5YvJRb3VUy+
+54uItkm3SrWfVEbe6xDSQRzngz1EmMrOZTJbH3oadejuT6E5NZLoG6cLrXPeQ28Lt+InigJbuds
BJ1jJqxXbniMxi6FF5paxunAMEL6Q+gCocbKzNdBDtCS086HORGS1DSUSBJCS7NuZMLmpsXWoduG
5DNVtvkHLgy+OCdEEt0R3gklnBJOsU9cqsP4p4JT8ZFMijvnzFN6ocmCGioZg/GwbP7VjnOgrR5r
N4GET6FeJPfSOs5lLT2HGom5bL6xTfjBhxWj1rtsCLV/FUnR3K6q8j7n1nrrLTHqD/g95xwuIylo
HyPERxXV4XLpXKjDMlXRcyj9rqJNpMtfQ0o1aNhesGqdAGOAFFzTabhTpA35sKda+2eam+qP1Q8U
iH36bJ+SlfjJJi16bjwRGwknZHb80xqN0FAiXq59P/lLcZebwNIzsgQi2GVSjF9qVt69p/H2uXXr
PfjpNH6vvt8UxxpNaZ/YKAEBNSa/KXtxsG9IgMlbkCzzNRlddbJdjZmTwIt6LSdMpWnAmHlDqKrp
HzgSBwf2+8g91jpZadMLkvKQkpZJOJn6c/fswFlscdV1IsUBVvHkuFZMFHrRIjWxN7daDWfTV/bR
DKgJg4YO8ZpSqkHccjIec3ULyHFMQ/pkMhUEF7dawlfP4ezD25IdJd0dZz8J4mclwvDJ8WDZ7OZ6
KDUe9DzfWeVGl0hlDOriQdaHeYFFTgyjPOHpAt+3Jlx6D8PEMJp9OWj/lHFYuO9WB5O8a3pkYBYL
n0KwBAvcebg1iGzT4iZHkMGJQv6qLsI0yTHi1WQr8R9s4zU1wUOxPsfWZH8AdLPe3uSG+47SKOzY
MJAIhlgyoxtHi/FExUbGxzWF4pMjVYVbTEfVfw2bGTGdoSGrKjtu60J0F0MzGEaqBRWSk0NUx5e2
cgJJ9tW49yaLR4W9nCxjgTG7qLq3wBYNHrAVOtm/up7mp5BdacFKvqCG6Qp5biq96gHWlRl/kwUB
9d+Y6UZYdkS77xRNL0xsS9pY9qZjjXoIMg9+Cjma4r6xqqzePHPDV2uPgjWmr1UDejrA1IINNBUa
zVfqDiZP6fxh8BWaQwM+eKbOqHdvJsQ8l9Hz2rsgsETMZOSpxuRod+US20OSc8kFw2XU+5Jq7JTS
VR642pudRVM2QaYSJM2VQq5bfnxixuyhUv6XobLkuzDg/nuYhpV4BXan6MohvzlpmVTLgfKh5ZFX
eXkr43h6gWiFEtCl5Fq5k2P6TEkvFWQha/+4VKHxkeJyXE2xGJM9PC7/Yw50fiWWdlsFdQ/xx114
QPYTlO3whE9gACeEDjVjxeVV2+F4KT4wDZY0/4nQPuG7t2+mwLEOnxvEwjnEN0+IElDCr9KMsATn
ZaATtlvdZd51XanHa2qYSzej4/wp+jz192D6Mzip/TJOb4sbDn/GJoTFUgOhLI2H6dsn5MfJwlsu
gg5J9KR2Gt7MYlkzobg4yx66I8XFmpJfEnp9tBxZTqv6Oc5FRCHQQgbs2S+ofdyLJGLxnqM2/MqI
E+DxTWyasArQ+SLzZjqWuqn+rNA3r0KXC6VggjImixMi1wS4abzUE/E+Z1Gn1LgzkDK08Fvuiazm
0JbygJhmAPkB7Qk9K64VHYqnsSLGrjtXPY515PzJOyjy/F7No/GkOI2GDHhWVzIA/uyK4agXoX6q
EMsQdie7gH3TzZFAYvKD+8t/y9u1MvfVXM8jzlAcQFlZVM8JaYJTbG3F5Trq+ovbezdjDqjuGgcR
NgXA6VjzOL6nCApeIWF2dbMJv71i9f+2uSBYgDx7biGNt5CvwPR7+ZK9w/5eK0ojp9FmB5fg7R+J
GM9rhGvnuYuVSS9ImrV/ST2SMhsMmsG8h1XthrvSZv3JhiPw+4iYpbOVcNW9g5UUDR+pg4EMGFvZ
e7uCxBubP+1RnO1d32DCBX3/u8I04W9nWlqQ/jDqXQco08EPQmPZs4OGEREQ0k7jocwHpGdo7ytO
oCk6TjNnXk/MzUPS0jCwQY5NJkoqtUVPEB5WIO7qLaMWQepGDzp5HsHM4WPVFcVv69poTFjwPZDb
Q1k81QuVYvENzZ8CuE5ZtgyDCCxIId3F7iKHJ9/ACghHDn3zdm38EnWtMGn6NLpT8KwM+8WD35SQ
37p+Mc4/1r34Y1WDri86yMJ7MF3yCYWdr8ArxalLakIY0vWIp9KRKi8qBTD0GZgi/BpUUNzHRR3s
VQ71ImqaHCRXFHJCXcUYnlyvhBnfcfAsDyPoMApXe5AhJxYaSG55T2sa9AscLT1laY96DfF5zmap
LqINSzpXdRN+0TBLHW+hsL8ymnKwslP9fFA+qj+DJmxjTS/8YDumFWbq1bZ63tAWGrK3YDgOt3SA
9STl+c/nVxsk+bGUobqAUuu/1pVCNt5S0qOJ1CIEYSC8k4pEBGRJC2ql5pj0NjOM/o+BH1fT+gTE
LjmMvexcGHc2O0PyIHvNGr4cGpr9fgZvQU4ZKXClDrlDlOGaPZCCwLFLgb30l7+4aMJr6vQCrVc0
86M7Fv53Iof6tLYC33sHUGHyi5IerFFQLy0FWamA4Y059llLdIy6+irbK1iR27xYmuxlnXAN7Ud8
sfLQdg4yAVD6DGupU7x1QwyStveif05mnZekVvXvIlnJF2dj1PyGoD+iWZWizPcOdJnnPhQSv2Xj
Ov86Xy+Uwluvvnij5Nytq8XOrIaFT9NhlJDU4aKzUgWyoLwB441I36jMJE9BY/L+rliifr4z/WjM
mbOMpZZCyPBXJT2vfVIuHQTs+7jIn26YoSNyhxcelzRoudrXarqzviIsl4RxkBzDZKzINKS3BPAA
oRZOHZgHrlVdnBxtyMvCIhwz7tJw1g4OOGfv05Aph5YvafAmJC/HW9ut8HD9Fm7mwqtRdvC2SBX6
rkudct2i8PUFXnUTA0DzSVv5pNb96puKTmg2RTdCvvabwMMr7YgQcHXFg8iSl5vfkd/2DGDEOLx6
TTYCni6E3nGh5NaV0srM870wGIKulb2a3EwweQCTcObNwnGncRjsuRNaGL8KTW7dhWWt0KSFlync
9kNBfJcy3iWLNkpEE62wS4G6u9WQgo8Tb//rCgEMIhh/P11PY0U7eGBFwpOcy78RDFxCH6YNPviz
w4shwXm+mU+PzJaGr1VaSYi7X35hOWdMhfOdmvvcSyyhlsZboa+M8NIuGdHQ4h2U2SSuYUBXzDNd
Wkw9Yc1JzaBO179E3uhnKlfH6pJnflnt1rUP4DW22KI5Q4L5wQkuglMTy17g+mzGm5+iCYbPuI9l
/cdP+rX8WXvc+CxE2NR2vptmFYbaJi+evWgKoWOayE3Z9XM7/ddVUTNu13jww/2Ey1BvsbJVTDOJ
FwtaS6P4G50KuYwDy/TVWI+Ebs3HuXH9YLqHvWPNw0I8DDYZYwZu0AYzX+n1lUs2Z1HFp+5b/SXt
wuUMqEd+qkmP/60XZigbPxua/kbUztfs3CGTJ2fu4d5loPQp3SotGXJUkiquObfBfaGr2dxggYoa
BPJ9j8wbHPcIBwe7NhtN0KHy6KDY8kOCw5lRNYY3nAfxenHGujxC2Jw1fN0mYkyZgaIhoLbaZqSc
MdXR2UVh7A9h3t+0dXSPtzSXPKVrMg7/5kau8kIYoTYXvlT/jmGDC4GWOpRh1+d2pfSaCI/7a9Y0
Ulwm+u5uu/JSf8ZM5tFJ/y+4335Swnkak/xhnigzeq3qEo9l5C4fYHa4GC0pxOEL3RTeSDlyOrln
bMnmrFuxaKZ16BReWE75X8R1sQcVK2fYqY30SRPU+f2qCBVxOWqmXQ5J6vYtcJfvEG3vKD/Gba1J
64e54a0OAzWeZNH6pMrgVqacOmFIzFwR4qYN+l8kY5ZwP0ChAh4iXPL1rhbzVs2ju58K17ljItv8
Xgi38vbO4xJh285b9558lPuS+9odbzBtaOl6oeFvJ8zcE0DwMfg6c1W8WSzIDmGyOlY74F03mBA+
oY+5zts7juIMzma/y5aC464u3mS4rF/OQKo40zgW3tn3IN5ETChKGnbx/6/uicONMxHM8NGiP5KC
3qpDSdpYP67crrjZB31N407dDekrN1Vqvam5iPxTnKDpkIuPynH90/erpzChglRK6R2egSBxjsgi
Tfu64RZ3LQcZTtne75pR9IeVrlcdHTP4IvFnEBAb2pF76a3/d+5q4W04sKDBgLkJx2eCUlGz0izW
l8l5zmtyA6iVtlkvPg3wPat/4qvhzoyFDWn/TVxfVmfDmzl95CpN5FNdj0H6oWnXLjABkJTHw8Gb
oennXqUjHqTkZg3Suh3BTwLUWTYlpk/nCM+BTkZo5nX0KfshqnHaptyiwOlIB14MwOEeB0vaBxFj
XITpAzU9JG7rbO7615YBTM58F5Z4RmowT8Cll3mPZn+pTSPyeVsr5dtlNzZTDZWTrHwqzE6SZI0g
mCNKm1sk3J1OahGc8B4q/Mj1X7BkMaf8ZV7rfcoRwXIoDiRaEo+Lr6ZrEXNaYMDEsIwrAhp2+1TO
ysxPY24yAsltW8QJGGpsOcFu9h1/HDZwV+FfbeYGme0kuLvS7LI4xZAfE2ikHJJhuCPDheViCe0j
Wc/bwR/z9A4ITmseWTmoXdkw2mUcWFqKSBocbH09qS0fY682iXDbWm7kNFHDdogqO1ECBY2zATWV
pnYMfmqfzt43N0y95MpFti2BiGqT7PIsCHw6SbtgvWvjoWB7dOKQwmBZoC+/1yIrLZ27XlHtGfaz
uFUK68gZ67qbPyCkefMhst1E77kJbXysiziKfjpMO5RM4mBSdX2KIg1Yx1/UEoFvmtXNDlTTu6Om
PcOrKbjoOS8VOUJAfUyuUplEHCTMfEuqzUtBw/uJQjvT32Egs/ImSEtuohv8IxQuZczGbof1qidw
vAKHk4rkr2PUhLuvSdz1NXI6Tx2x0jCL56RkfedoUGPoe6T1PO42CQBkRe34ittlWweAPbY29O1w
N4vWZHsTY98KzkwvbH0KomReiCfWjkeapRjzLTDpHDkKiuoSHh0QOF18ZG2YiCt2Di/Rrhct4+Ai
X8T0wwim6JIDXEwBzY4MMKi+FS/J8zSls/MvC2OBts1b0fxtE8Fg5Z9KW8sE2K/IlwNI0s0aUbwk
0zojZtY4CTuRo9hBxXZG3xDECunw3IWTV+XHAn9JdxBmcSAvZUjBDOXQ9TZNshTDgwdojOGs7Mx8
GcNFgzfvlxy8KeC06CnyooptlLYFoZpt30xZ/doGWR39E5DpF8ASjVNfi7TkhKpiS9DX4oyXkKpL
h2GXRs1y75K8F5JRquqCf30ZLBAYUqcq9xJxuQcNtkpJXLeY8+F+pKfolyO5LANmdqPibzY7tj4s
lLkpGLfo7gVaEjCzPHHr8zrjRPg1eLakDjYH4puB9GiFPIwtg4L9EICppjKxJsuJN2xIPuqCQ9DZ
N3SA/bnNCPS5Z8MOPlkeG7sNp6LJ32MRLN1D30IcAWkDKGfchkWTrHdROffkCGQlawAsKWsdu8UA
m/12mQjlIVyTtKmBYoVmPUR94tCo2xVUYBc5lUNfoe4T+QnXvFNXhCgOz5vIYQt4LXx9i3dxeaDy
1qVIeKXDdgXtUbBiBQySmQpGEVNU4C4g2dHEnIawvS7LosNM4FBEcAhWNynImXHsjS5oObU9r5yP
1w9I/q5/aUU8CAcvVddGu2ZcmvmMT0e29yNcpvAf/7tw0XL8qbYPYcAUqjwjjXA5I4+UTftSLjyR
XH3iMDtPWVmJA2z+OT5gTsyLFwfw4rYcKm4JrIlCk7VhHx65VXjFRISiivloHirGV9FvXdXtAmZW
j0t/mYLEKy891oX4KF3W6qdZ8w+nwHE8CDsZIWAgClDgQs5YkcFB8GRbNszt6ndJh6izyC4+6ymp
qc0ER1u+NhVF9y+sH5gqjszZ1/Ily0tTUKSaWpbzvijL5ZqIcHQ4e49pCcETkOHw7hdW1D9jaZzk
RzftkL+wItdMohq/j3cda40kKWNb/4BQmVvApaRoTmuCwvQVdDFHlUMu0aYeecin9m0FrFUcwFH6
3fwy0OjkXwt3snbPEZP52aLX1L2B3oOl/AArwRR1qbMlWS/r0KTqQEg+d//5wUwXycax4bNiEqAb
ZiyPQTJKglYyU/yQj9lSxn4PU8sF+Xsmaz3MRHGs01V75MB2/Bob12Ix4wwzxDxPg9sQzFXLQjEA
MogZWxxcgOoflzXkeyLuEvL+fsN4X8eRlGo9F98yDrgUIkOltdW3AFJXe1c3zNWtlgvVapu27dBt
JQwWWKEUDYg9oD9oDbl0c1fsi6z07YtvirWRx+k2nn+VeU2i1QzspHhxaOSQZIajrso+9QjLrtmH
6YRbE/abGdf5kDvMeeYtH2/r3SfKHfwHblFl0eKVwbjxBNqOr7vJsW7lJ+wn4NpK9vDkI5YSpOK+
seWSMNIfe0peonEMwvnQ+wN/aYSh7jmDKaYJ5kqHGYvGWTdDnH9Tvru4ROh77z8zme6T1gH/uRRG
TxvPCHsd2gZ4u4KxTu61c6jkobfcw7BbYnofcEWAPD/GQMTWfRdSmFvTAzgNdk9VhVPDK8lH8xJL
r6N2KLZ5+WNHZL9HvFxy+pTDJCP2nzbxA+I3Afc8cOqxLo9YJgce2hXYJf3Wi+MvV3fu/Ie5rNND
F7cgGjIrMHUSMxZbh/pm7pUiFSjDrt89VX0cneKwZYbe2daATlg7Wk0X0sqVS4YT+bDeWZj5YNSz
aX3xs8R/ND1jK0YxbfbZ5Zk+pqOnL8q7lY/MUeedXSXEp9Y+fzy+ZZb0GifvzRAFu1Qb54vjJnHU
XLl3ZJZBVI2NWrYzO9FhqBn66Ur5NCepYifWbGWu06feUzWW46MxQkiQ6fDLNiKHhuRxeHiAcE7x
pLd69xTbOgyO0aDPdTiWr848g7qeq+BF3igV4xqB+kKqlS2X7gWDHyvEO0CxYR9k6/ARYCPe0klQ
gcNokh3QNEhP8dRfROQqi52ta165NNHywuXCMJSNqvhawhaNoG2QbEdwLD5oJGGsDB7tnxMkenlk
tJNwQusKH/JRbP7r+6mg0Yhn/LZaGvld+GtHIDx0k2OrF9sd+O8xd1KFwluh0odw8LI/JWGzYeN2
vXrDMIsvw180p4Nx8M6drsItKNj4KrWHxCgSjCmStiS+4c6nHrJuG8yW9YCFhh7YDtNk14PHy8o9
QERJjOzmzUVWjxD+ZzL+bArOA5Az2lvorw+eoPMwRqvzqfvlWIVvlx/Y3Hv5PAHuSHkQk64o73MK
3rOzi5tkG3px5TEUDeg8oZBLTtuw69ZdJJblQdMksmX2BvclcaiAryxWHDYVyaPRzlS2UBK4xegT
+qdqgmCQL8CsqHS9gRB79ESmwkjdWcFcfmu8POWmPmOHV8S08d0imhw7bfxPpCy6tPtsPnrhSr8Y
2XJ4nL6LTjBl6XnGk/G4BFV1WSLDaT0bNSgnunhWe5UrrymXu/K1EAztUQzCFYJYq4o76he47VJF
sYEm1bnbieEuQqUp8XjpfCABvuYMZ2HtzxgJKGFYD7FENyKPJPs9k0JVPaBIeneT9JlS5KQWd0I2
odhxmS92uAm9c+rl/Wl08o68IeLsOWbtOYNsak7BmtuzaVEli6oc7lL+5Qfm2eo1HbichqtPK7ZF
FebOEJpTWnrTYzvl6TUOTXQP63bC9hVF+YM7kog+OFoHL6aMsJR5StAVP9biEgez/9dB4clZXnTQ
+OdFgqc5eBgc3upYFL+c3NZvslqgK8+d3Be9y2CUsqnkxKmVqUY8GmWudgjfAUxyyFxBdifWXa8N
0sl1mDK4NZBUXNKBprlPsbN8hG0Lkqkrc48ONB2SyiHgEJ58S6wQYJbKIQAFvIWwjMvHrrAYikI2
GePzuG/K2TXXDjtLerAFDVzzGA7DxcfxsuXgBzki7Gb7kDPR+6g8zPwzlF2ChoZatYXWr90aSTiR
EGU+eZ7zO2p+EwgqnDb2nYjy+6aIA+p8baYfLJsT3k7mnOwSzKROOiSrgTBq419I0esVPhuzbMcH
EAnEYl9jJk02Xo06mEjcxCYuxqeoCdddkXlq2yPTHhSFlQ8+R9RrVKx254OXoysHOKp96idLaVG8
ttkrOeOJclQwQezaMjm4rDk/gNWWBlI6dys4T8EX568IzqCkXQhiinipCHacQuDapNzhnmTbtZ3T
3xn77CdlC5C/hhzeAA8w0zZyXBOX6kLP6W6c7MgoX6vvpovjV9N0N1YwBxeUlr6N5Mlj6gHcoulH
ip0YClS7gNnWExenifuAKt96vMJ3XuNFv4ZQWkWFaLweh2Cd6scVmwtQqcif3xIyug8JMRcGFE30
7KIhnZ25m6B1NKTrUe5D97DEDl1u6M0/GDCVeprn3r6iQPagYNN2iHYDZ9eJdzRBvlwX6tl2cV+M
9B+U1Y9y1/FstBIX9v+s+9VlpRfRFeS09RlkCtW9TQDxlG7PSG7qYna5RqTG8LeOCggW4zz9UEgf
NG0t3f7vCLb+7eaICAnGrOZcxyTx0ySnqNZpI7McExk760dpm4Dy1nnmz5/44Atvh37mD/+Bn5KM
1YqUOSCTfdw+zixJhmSBk57tgld6T2S56CfmHbXPYdBEwFofqTEaJwTKKMufY4fZw+2G79LCu1GU
MNEn5CSRB/B2nCBzpQHA7U28DBOHI4FfpcfcDZrL8Rvyk5tyTZNBbgHCQS7dyNmimXkLnPKQHw4r
AnNCgE585s1vjOQlp5V8aIc7TmBRvGkG7T2pmaK5Z0q7qAoXQdiFZzgNxucCyVp4YRect7MacIDE
ATEC8PNhxOlJTLAHccCgbAu6oot3I9zYYKzDPn+gqWNeYQ4M8AYC7n94EaOo//TTgItiWHsK3kja
2P/o56L7GvabvbB2iS+HowZQKzXw24uaw0+P8ZOXq2UR2VDQkgO+AdkRwJTwA3OKZ7iYiP0pzXS3
wMiaOdb/bGzbtr9Dk+JoWOHLl1vTCYk4KkIGsuxTHIEDRNr0bsCfCZcg82/Ow1nGbXtHRr4Pfhm6
CmBAyDVq/5WgMwXWAT5/zqrgC+Qpsn0b/EGrnQ6IGZheoUBEhq2kKfL3fikw3EYTU9qdTSpKA/D4
tt9kahrLbr1o96XpEAmvDF+GCpVh7gN3V851UJ8Xawg17Z0BYnixVQvp1jMqZPeLSym4pghSy8WN
dG7wpjtu/2RmwvDupomnGktVy/7/brMy8HbNQlLhW7kdciW0Rr4QiGXRgoKW+KDUOplGJ84gouEE
BTNj3TkTnQWAoujZbDYiQI+syFfE5N2afT57U/zIdFQclO3y786DJVT1jlN+JevInXVN0VDofVQx
5Y4znJMR/PACDAuOWl710cm4aX0YBiefrwLxNWZ+kRf0k49tP31HStE0EmdxedfMfhY8x9hvfjAg
T9lZ27KdmdixQd/icYQv6iT5Lnu/55cDzvRQzY4++UpnPxlVLxeGa1qfbOQsV9y/P04f0Cl/zILU
qz7XuSNDh/ylABlpfKqABvw14GcGYNGw8AERdx6wWNWGIq+lSr7b1Vf9cRABLNzdlDGZxUW4lAAn
FhNrCnVqJfCfc6WLnNPgc5XdarINzqEs/Vhgg5HjzD2YCBXWrDyMivSpmpg3H8toteWHsM3CFK7t
IsBB4xyky5/UuXXF5xzbISOXEngW3icqifKgtj9rEJGKllQL0Ak2Thhy0M4BwyqzCJYfb0CLgVXU
c9vruuq7oR51hkTCToy6kFgl3sh6RLLkMDON0X8Nw0coFfktl99NKR6WBQsY/MbKpECpx4Q+7yPF
An19dHxUmD1Bc7BAIumLiDk0zvv5lHZlFNnt0qsKDrxFzLtMdOCZeDdpWfYXRVM53WB95tQBBD5v
zf1SvdINPSzLnQ4EXXkUDnbDKnc0AYy461E1q/nB9KS16i0DQr+9caGs7xPgQQcHrKBc3MAonU6x
0+m6/NZ93/Sv3pAU2V6TTuYx5vSiU6CnYuyKc55b/3vlk6KKFccpxDPVhqL7rDpsB+B2GdF3WP49
TE1dEC4Ylwxoye7QTyC+9wZU08QrUfpL9ejW/sRfOwCgd+/t0MziGepfpv03xKpM752wMxHVJIjr
3JB8oJzVZlF1B33KECi7JriUbbwrSJCW/2xuXPlNNwFzTABKGH6dUTFXwc/+3BZl4l24+LoKugXC
zrPsG/yotfSc6W5O+XheIca78x5g6QItOc79s8qxQG2c+qZPtRPEGbdDIMUdD9+NVampz+B1gjvW
pGQbjsymLvj0cRHS1v6dM1Xc5XiRvB2YpJ5M05RdAhNPzqEDp33w2sC91tjaxy9A66xB+97LQD0p
M0xudJh9v2cTJZUGHXHRi5nOTWOU2Ep+PsBSmdD/rVlNHId+kuxPIKg4HKd1AebrlQEdgxohg4eU
/q1N0Rl9S6oK190mSwiuO5uGA10wNEFBtZucvfIHe98VxB5ZFOrqGQtsfJGNql8XrLExt8luptLc
az9sz2hgV8va34xDQpKXQW0zPXqCJtfT0mkX+xMO2OGM32K9yz2PUAleXNBA48A2iUSMQjBuxjKq
s2NLVyH/Kl/tuStM9phHPZcwO8v0CXVf13d+HY88+c6UPisVGXj65MrvZYsnhUs0Y1OPkSg86p7m
z8dqYJB6G33iWKfATLw07hgSdi06b7viyQOSWIRUYUJH+B9JZ7bcqLIF0S8igqGg4FVCoy3b8my/
EHb3aeahKKCAr79LcV/vcI4sMezambmytE9e1rrhriYYo/ZNgD6/lUlG7Zh08w/PKaqticYQynRW
oqRVmM2tB9BglH6OuNh21BfABItmHPBYYKJqm4fsWqAh6bTbN8LJRkjYglMcUTe9YlcokaIIElEG
zWK1i77mzOpeZVaH6XYkncNzUAEcO9WePzkHXibmZ2nJGpDBwaXT0Rvw5kYL7abUXAFTw3BS93cT
Di6CoGsUq3LKp7irZnFi2etl+0SDAvWsDLmtQAZ/Dww1b4SLx+W/zCexe6dkND3XmfH1SQLIfnVM
QFGObY3FwQcq2e7tiPPkvpaDOOq8cEEr1k4tHjWblKemzGEiC6P8ByWH/lxUJAWBtNgxXbXzyV6r
6GQo7jn50LT/yEiCKdQZ63Ehyu6J0zE/15YCiLrfBSQ7/sgxLY41acwjt0pGa3BmGMA0S7dzvnC2
OznEQghqlv0aXboek+BR0VWW7W1vYX6rQc6Kg4WzFbtMYhDW4Uv7B5CEPehi5lRempP6b0hnjrac
4WGxzKtZYxqdu7uCvTx3M4VgX1GGbPPi1Hid4mTSLDwEkTbyGxmyMe9pl0NDMxy6QeYmNhOA7RmK
K1PTVIIMcn0sBGwLovHUjo4P7plx4KWPCrY6noJOxH0JPanuasXk7trRY2t0wnhN0HID1ji4Lk5B
jG+elwaua2ovcCmt8SkBO7tfS6s+L1PS74yY8B2NcDJqwo9bC1IDIY+pHx6WqiTXwm2nOHHSPRg7
E+V4vmLwQC+W4Ch9t35UXHNbjwVnTLF3Xp77yk0gyuvUwudv4d0MWJpnCMaD9zbyYNJsUqU4ZKGF
vSnPJyp3ZpWObIC9ClcRi57WPsG7Lqw4sFSErWBMusOK/HW2sOYwe48EgPe4YTA4r5QeAwEqW5rS
iSQSXSpcTIGZPaAnu2PgL8ccgzh5azOGTBmuiGJ63ubjYBtnX3olezIqTKy/BMWzA+Vu2bff48ml
5cT2TgC0MMQ0WrZyA/cP+4vnJd+CXNG7KOvR2va4ps4kzNp95o+0iIomKr4G2/FefNfPVxwCqBTv
ynLmk1bC8fYNahEnw9wFysXVARbAz7PqrzWOwZNKVqs61kSAKcTw6NBzu9L8qRW5QUHo8dosXRnX
uJkh3ekZX0Nn1ZRiotCeFGLuU1Eu/dMweFXynKOKPnYj+gt2BmiNmxLDEYv8hlJwd9IpfY0c/+BN
Odhn6TjmAGjolfkTGFquf5qmTe5RE7jLmsaTHoeQNCCMzYrrOBS41urNgO30cazboSD0jhXCWmYk
Q54GxWum7KY4jokd7Bw0IYaf0Y0Rk2fWZZijC1smL8J3OAAPRLMwgtGr/M/0Gq62lbHrB+aZ8lAl
vGLF4UjIMFPeQmk0voGXJVkw17JQsw+9psSPx2Zbc8ghaPEntFbiYPYUbpWj9CPdm3mwS1seG1tV
WA1bEEaOCwnjroeYtCQPM7PLu1FgdjbB4Gd8QQmtqGHFhsttmDf6ofK3JiinZw69WXiRA93sddt7
96Hbz8WZAvEa+FyLdr8Jpo50ki1qV30gkxQMqKh0/Wn2+rnZExyqsfEir4YQoFDRKq5N374kXB/q
iPNg/MFHUN1pufi3PMg0ku2OfBm7ydRO+0DROWZVhXjA6wHyNxOKbVo6t/pohoLGbq+mioW1+XLi
v/YePBrJgTQ0LAHPN86lc+mIqz2YyKEH1NP10aJ65pOzazPcLyqal5PpJlpTseSyG9+EUlAeaaSC
FRnAdzjTdZTf160i69Vq6sFOejYDm2e7/JfrhtNFN/v9P0BBidjglFGEXunE4/1kVZN7Tui1aF+N
HGwGBRGl8PrrLsnJBZQoW/Wk8EJgnSyO8FLLJ0u0Ij3U9S1taRxDjArEX6fe4Ketub1ZhjrAXVYv
jt/9JTSl7iB8aDpaJb7tWINkhIWAZbXa4eFmGrFdSt0OJNjovAE5UDIM1qOmGGKMyNQAC4l5a5tH
hte+/yQzQvIcg5rXnmDWJ+FxFVN6Xhdr/g406+Kls2tcQlHyWS0kfq63JbL5pJB5IY2GyttSFOCW
X8XC/oIO33x9c3DUcEWj8eJeTDiPPbhZ7dhxSZwBk1zg5cce8ni4F+0w3fEnQl/ghND/C0Owpu7q
gA+2FI6/ospdQPs0zzs3E2YJhbZ0B3mDpuPDBy3QpeQ0sM6kxBDxF03Jza6WmfWLh2OOhsOp3EuR
JkjPIrijeNJRSmIaAnFistijle1iwtWGNqEr4YEOVfRxRofVzftfNxi7KyXeKx3jlWDpyKWA8l9h
Mr2WoRM8N7faaYKCYzw0i7Ozuqnb8Xwp4sUN8epSdB3Or/6EHcNfi+GAly5Sz2Fjp9ldJrOsO3i8
AAq2rtQbn4wPwmOXLmR+Y+Ql917XqFQW2ZhT62U2gTcJ7JRGGdSbiPWvp/nDoEuMjwlWuzMtqNUf
C4TMZ58BIuClNSUElUNcNjVZo7092bfHZgbLgQOHaFF8cmsfaF8HR0DroJFJXuitseAGxsuyEicB
AUM+Rtv5iO935LtriUtAf0UMnHz+6BZ5IR7TMaR2DQy5rFlVwNixyM4zMR3wa8DCT7Q59moCKsA4
C99G3HJQ1GqY/7gRG7rjYbM+cKx0oXeGgtJxfJF/jTP7XE8sWjc9/WCHlYaDC44WxF1tknVHIqB7
XNnBnPzFnQ5qpi+IwRhuIUdbxMsd34v1Mgw+melsxa1ahCj+rHaGdjcNAd9rxUlgZ5NO+LRT7s1/
i91p+9tasEy6w4rR21lypnJyyXU8yUk9EjoKT9qxWSKV0xBxikptH6ErjTTu2HVmZ9OY7YCX+6Xn
THPUKps4zWRNccjZCGPm9xdMoV3fW9axkg5zhfLJ6+8tYnBDvCp24sSrA35ZX4c+41O5cpXxH5Nu
0VCruyqqH/qp0ZeEH/we3xABsyqhQRaeCYFi2loIp6mUqIkMh/rMcVPsiISEf/VI/Z/qtfC2uHD6
ZGe0jUoKcCMiBagBu1L1aL/6te9170WXCSSlUJpNyWalOvqyI4hbZrriuRASlEcsbgKo0tLL033n
CAACHGtoQZEIANWr0w9+iKDKr4cUj8pwnDypw50jG6fajoOXRceaVXK7q8CzYH2RqOpkYacgUg52
bpORD3IhqSA2+1V66CxlO0/kTMfpMpIneawzyuo2oWHJ/2RLjYMfk6TA1YCudnCsFCgnOwXc7iHx
VQX/Y5gBCRbrYzobzT8iIMhDoPpjRix7Zc7EzChEFtR32Jpzc2+PS4lBz4xucai7IQz3behb+j53
usi571c7EKiVLqb7ZGjV0Wd584FZtfieo3Lq8BaGmGN5F3VvvcU5yubdnePjw5en6YazMsgHjn8g
I8vy0UchJfvazRgT3eKupHDlKzeV/OuFIrhWaeS7l9WpTX7HeQAjI2/3uY4zdgksXtk9PzSwZv6E
XpU/an7OKxb2gZC3rApqX7A+LtM2GAVddaBfXO8q8SJ7O88devgM7MQHKDOEGLaBwfOCeEEl+mpz
IlP0o42OSyvHkEw4DFNG07lPKEyconmf8A/8r6rh16CaW1G6k2k+3riMDlHGIhuicL/QMOOResFi
8i5n7OqHMMHwspN2FJ2WEdIl5YXdIwBReqHWArhIzKcZiBRhzjvpxiz91izr+GHKtfsXhGpu42oJ
iDI3ARPaRpbj8pi2mAq2s72CS2hxQN3LgLXTw5yutEElXovjVLY9inKYSRbZSYKF/bKGaXW1ZFfJ
i7V6OFl8Llp5oLZNn93Vgl25OAElLGHyx54xO/AUBgN/57dY1i4wr+o1XmxbyRj7btVSrjTYj5Td
URNRmuTa0t7xWmIp1hufnsD+rmW+CCEmrQKJrsTqF9CCCV86qq2xgSlYszdL2Wmbbxp4WjjeBDkT
LO6+skGCu5F5TIskGUkC1e1uScvu6I9NcWkpOTpCXVrcT8T6EF91yeSQFfiSGeoGNTxbnOgFnWFJ
GJ6Wwl+PqFoLKTg1iZdFjElEOwXnCvLexHwvEfmLlVW/5cUQwPM7PUdo4a6Ds+5sLFvsC8vFVLWl
JdcNvipn9orXvtHNjC7aACAijhW5zMctfy9quSOoHaQ63XklzcODAYuD6945YxQ+lAl9JDrXNMX1
7Fb4uGDxXrD4R+MVd77kkO5kPAZCtngoFfDP1DUS/qruyIuWk+CMQziAX6Uv/9mMduLNqzsrwo8X
+CbaDJMd3hmTwvdpsxZHBZH8QfOkpSZnh7fFNH8dMek9JUe2f7HUgEuFLJT2yQiM9YqMtWFHRPnN
BpKUi90q8ux8o+S4XLhRFF2yGkZRNUdx5UbY33N7HA+rxUZxUysBRajxojLZ49bwz8XCPO7C5b+v
CXYQqljgIJPb7fAXOAwJAefOS5W4wY8JC9UI5gVyKk+uRajkCDCKxADoA4LAFJlg67/Bwuu2mi6l
jBr65chB9fHEnh3kg7OY/H7kBJEdam9g5V1MrL9osvHy6eC1FnngYlDyvuxb23wTk/G9N0X+6kf5
fNCsr5ti3408BAlBawhrANpvLxwZ7HC7j3LPHtdeT4J90WZxBsqPncAm7Whg0t2PHuBsaCoOvbJr
My/+9zibwDmmg+TAjdcJhQP4Pe8Nm4LA5e8CgvqlR+BawEcZjZlw21Qli/ulKUv5rxqatvhAgLDT
I86GgrJadEO8IiqYAbs7ftHvw87jtFv6HSWHGk5/iLwu1UkwUaBIu52u132PoYtbX5BsCW1TR3cc
gim5yPpw/Qk4yt63Y95/JKhS+ZM0vnxgObSWcT/1ITWABepXtyWPYf1Xm7538OfI/oyIyZMMbdC6
r+hA3WHxrAiMShzOTjEcqQkJqAEpW9gfGNgLXKStcN+sscb7NYla/gAouB3cTFGkxZeOnBlRcsHb
Ns4zA3XArZEmLToOfBkeIa5LjvkdTy3OLzBdPJr3cJ9wiSrWt3IX2WYdj7PvwpGqWCx/UE7EWoXF
YsmCyDcJFqd6vaf7dAbrpXBRxfzxLTncJGIvMxaI333PzUfk4rmMivygp7Smu5F3HwlSh27S06T5
Ozc+xa30oRZEUh9HKj2HK0j0BJNkEOS4RjX/kyB3bsaXQV+5lecrLCbnXEx19eQbIyHS24n/hw1/
eMErPsTVDGCVFAqTJeg27N03lJcOPl013jYi+U0HzVYia2f2wvmX10XS3xCp9x46+uQ8VieUbvi/
CPyYpBK0tU3RUj3m1e2tPMgV8zcUkuiSlvgndytxE5uUpr0cZsHUcJhrKxFAWjrl76qlsN81fnoW
ikJA7EvxAQ9HbjQJHI525xpvEqaJ+rz6Rt+roppe+xD7MImS1FQHGDimjOlNqykEmovmeeW8vPVN
Vj30CN8z/dmhT31yuIKLwJsmMQ0eBsw6O4uj/n/c/qSiLO0yfTmkQQFWjWFy6kAeh8eR9pzlSPBr
fevWycyHoBaWeC77Au0uxbxabenQgFmAmytgHR+CUfgiXr5yw+o0iK66YIu15WDefVAPOc3ALmye
cDUjxTkIsoRsLAzu/k7M2pm2U6jXL0z1ww+HBLrC1bBAh0tmCFLSZ4WYYlfbrxwAX5ysXNkXICzY
+4GAWbG7dZDcyEbYyZO959iY4woHUynCSoZnnBenv6fN0uuuNPrlOM9uJQJN2KjL7PD6uxJhmtxL
5FTiLGpR25zG0cpOWN17785yAnhLN2TwdwGlInTIazcdkQTLrzs6SVWYPVT4pItPOtmDk/IxfkKw
GqlvqVL6aJ6nwanfwpaZr4rojEXXKbu7smnXIpYBHJsFuJSwP0zWzr9J3VrHWbdutl3NAg7e8uWA
2Kzbf/7Ndrs1Vd+7TwQLvGrPUGrhCawkhCeR5ZTSponVwSkfhgvkBDSDyBNasSfEInkK6zHZSRq9
SCZzBmXkGkJTd4d+4DCJIX8VbGutyL5WznpL5y5e1eGjMrM4OkQ9zzUue4DwU5dz+JjXE+0CgbdP
cCRik6q51vHoRmN7Sps5OnptlD/5Pt4jsFxO89piyf4TeUm4dfE+3eed7v8Dg+45eG3pWshS277w
Ip2QL1X0YRO1nDeZwo7E1SXMZcK4fm7ZWG5BjmgCnC0b5ye0GhKCjkGTO0cZ+8nXhQ5H3E0u3JP6
e1kte5/MJCIZ0RObf7UNUmmXuR3yBuchDJ0M7W13P6c23NLckO9R7DjcXRhQlE55Q/23XIx1thsb
gUMp4eMwg5O7iawUQDNu9uglR5y479qufMunEQMxXz6UM58bYgoSu49rWEzytdAWImhnAo+8oo+V
8Za/wDgwDPLUoEarq8Itj09W9tVf2AjEJTIxswz1bNjqW7GgjkGr637XqG+va76sv5SgijdKai15
D6uxoRUNoYKbBTXQY+1BY8aOKuW1eDO5CHk5sVu5YdGm+Q7hXlLXUfJSPFEjOZ1SNoDBfinUasUV
iYwDL1Yq05j3x0dexQolO43qfVjVzrIpO6c4yLEai32hCvven0reDxZzEEhHrigLxGLU/LIihjga
EbzACKFvO7Bs0Md1jVgl2hP0CPKW1Ykbc8A35inq+ATcoypaEneXNBiSQFf1vArhmxGVSauhDWIN
aSNDl/GKP7ZtMlqAZ3lHU1bPHC1obUC/T/HD9UMQt7UiHMfFAPk4TSJC3SGg1HPXRBKcDbCjhsAt
oRoGN7Q0ZCKHpNSetMgM0j5ke2nmfHopGpWRYutI51yrbGA0T5al2NsjKfdgvDVrgGFY3YPT1zo7
rQ7hDDhaQfbasY0GjeP0Krswa6SXKSPUAo6UIYLHPQU1ooui5gnJeO0f4SvivIKIp8P7uZfoe81S
K+/coqpz7YJexMJlpYoWlmFq1R0lpXWOH8dqyLZ5EYH5BK1r2aaBR5J6UIBvyVPhLIzxDg/eFmQG
DsnITt3mH63kzUPA6+vbK3T4PFtiOgqL2nUyBBiZHdudG8TfFpleYOx/KNpKdXvMMuHj4DvN++oX
JZ1bkzIv7BNl9hyRZZE5RdaUqX6lqxO1wMXCCO0hcBSbjWEksj4J9g7/wjytxbfgqPHPVAux1L6Y
5ZdsqURMMZCERNJ7ibxUjd7Va/yeejjsNOsrc7J3e2OxsaniNNCrPFYcsLq3gArN/m81hWn+ywkj
J95Ap055Dtee0DnCEG9eid63YpStKLCvwrQBFyLr8F9n/OjdTzMAGijdvPZxW3BdoLLq6ZVlIHfm
biAF8eBbk5M8YjnEiEiJ1YJovOSh/xGElbjOllO2x0lVy8kTDQYId2lfRD5hrLJFRHxRG+hRKkoo
4aZiazlT6hF+dwoA1Z+GJMZv0/MYRcwMGiq9/TrqHhJ8Ft4JlqHf4CwLOQtowqBsOSgbLbpvjnVq
+UuEqi1jYsnuf8px/fpJ3igfNlqAhx+ySYbm0OMWIiIecqDceLdGzIIn78U3iw7ggEj3Z3Kn4OhF
HiYT2TXhzksCrnIqH5qtLaVxcG54/Q7AAAewdo4IzQDBWE8Frqj5U40iUF/wNtyCOWdJp2/tKmN4
K+fBB14Do5+5Upz+HYiggh0xRwMt0zNbQALcbfnEMwIATG8yrB+alb0KehpdZRTdKeZwulMSByAW
cbdRHOtyrrNTVrjpPyztsol5UrtPDK7jOWpXedt7R8Nvqeruk0pjQhdFmqojCY/hWQMKOHRh3/1M
QJ8eFL4J/RLaaY57xXKjSzC4dPfxKWzEZvyQwKqYeopfdvHGSfZjgVGFIK1H9xgRvMXfoY76CdhW
LH/8al7tm7/JmntAi1tsgmMcFeC1v3hy869cGZgSdj+JeFAZJ6eFyck99wJRBfPTaqO6GNvJ7diH
N/1ewvgoWb4VoCsIm0i55Wt0vhj2JCSWrFIFLDEixVzRszVmsQQpbOjuwKfySYihwARoTWK62nXP
1b9xSdZ09yMhwC5u9AKTxh8yfYgKObEwa/EMxcQP8xxalyaIJcKpcZ78fKoYyAc2gm3vc2xY8yq0
yNjq3gfcqjvq6CHKNz7e127+SwFJs9wXWcgCeOqL9H4mB/GTR2jt6S5FusOjZrtoqB440xn4RAI4
TVdrduWcjhNK9yVqmJ7na+IBzzZbck32kQUqCkpDFODn1iW3vuSNqOG+4us4eArpCQ2PBw8kt4QW
K1ct6pjx0sW4zBVdD98NPZWXgihKg2jY5v5/kypqerqzpOTYhqmUa+YGhVTJlRBWW71RvByRU2BK
K/aLW6a7yoVPvE+TbqHBqy8iGodUmdR/bMJ7zocXrA4WBgGh8G0kt1B+hHgQkEXxzCbZGWal+4Lo
RyUJYVBcYjYlURTPw5MUIkGXcLqsPTQeD9uOM319L81MxDrH6XqlJ0/qrTSW/8T2O8l3pQPD9s/g
ZiMXCCTRYDgw2pA3gbjIoXdyTwmDDZ2KTYtjj57szIq9aCSmgNuI4KWfy41NypMmeeD/TJXWStlK
aFmvzQDG+xDSNZffNHsnvV89C8SeV89C3WnDfv8ycPWoQ6l1xBwoWM/GaZoP91y/6zugLV3xDuow
I6sBx0kb2A6SiJOr32zux3KjvKagl5n8ILdFKLzpYPvAq3bL6BgYaMVCuMLjpA65qFlO7WwXNPwU
lOHRn96yPCPUcXI8H2K6DEe0lNolQrmpnIQSYq9N7xFFipfa73CEFJ6o36MKiAknnDb7Qc1Kf6F6
2lBIzIQ1Gw8nvy0ski2uSA/IlOWndY2HbfUr/V12SzAdi5nTfklXg9hJcDv7FM2CDCwdCAx8Pni/
9xvmrGB25m7e9cw60cajBq7lmmrdfoctdIrJfEEhI2cBd4kF002MhxgJ5Ktt1o0zBXRGsogn4J9X
DevoEOcXviDfztmi0DF637Ar8Al+wtbc0FypyDjoiY1KEiy23q0ue0uuq35xkjgsVhN+dTyQwLZ2
7DJeIApa+XOQs7x4QUhkIogc8OxHpo4le1t5DqY7mtMIRnFoOtXoidBnkungZy1aeimWM1Z8wG9Q
Ro8LmV96aQRFr3znkyQ4c7uTbRta/YGXYe7bmxT/AfV4sofJgnFkNr80D/JHsIRdQbY5Dok23PaN
RmUduBpeVi7b8jTgRyAFN5CWxS8bhG8h9fE/8FG87sMiUEGYoeFj0KMDNzSQ8r5gQ/OPk2WCS7HX
FXr80Hjv1AYm3pHtdnGfcVTmfFp6ffqEOcXFKbEYxOnUpBf2RehlRYqw65MDo28vFCz4JiGuQ2OB
ivSdmbSRYC++44nlf+KYsZ7b0sUZKrSAtAt25DKPkE8ycK5o5KZrf1oQXXe66fWeYxdpJWHX7nHC
3/CaZaDxLyH55hh0hGVDJxO52OJxqR4z1dNkOfEARTx1DNI/2pe3Q+Wl05k/cHpZONy+YoQP7ENA
5JGvyZQda/G5BP3vy/KsfSWtfdsl8jGYBomouaR4ELEXuMN7FtXtH+OwgSZj3LfY8+wgucvlAk4F
+cF98xDSm9Ncr6a/UXx0foR4kFxSzcuPNNxtf7YZIlJEt7tNO59UKQn3hylURI8DltH+ZU5HSlJD
eJXraxj1uf7qQYbumy4CShs5bUmj58pc9biy8Y1Dp18+XZds5038+gfjEGOSrQDTNgEWq2Tsu29R
L8wZHeWI/jbvivIeSnIwXr3ZY2PSMtyAvPJtPJW23x8J1qbuqe8ZNcbQRzdXLf/DTWUt/XdnrfOn
ZRE8B2mlSCMN0wGoiB9wNajmNFluwzrP5yOiwi2hepDhhN9mVVVxcUIoNM+QMNwEJ1jgHnlnrHWK
4RUPy46FQ/Blg7S4ktekAi5vI1ZJq3Y5L2KxjmvmBbg5Vj4ewBVwrgf3XP6XRdaMpEwhz4MZmnr+
UUWIyW4OgkVCuhn1QThjNe2nCiTwdsSUTxUyFKUvFbgwVruWxLip/NDbsKsTj7wh5EvF6RXjiZeR
+WjC8hdArboA9J416W3tPUExLuI65zm9Y5JYX4SMynjppdUcaI1ed/R1ESpNnKUkYwKJhQeTfbAZ
tt8yQ1ydrtZJfA0L+W8OwvxMM+f62LE473F2tPJ3m2aCF5IN3RNpmB88qeYXmn12nKHNsLwvq3OF
VeboARNkBS+6guWx8U9SSkA/+S3CvAntwe638NbNnaPzyNsNFr2aeAlT+ypEGPxoxcMa50/WH6u6
kcAvRvfDZZnAkmhULo+HIQmOgesjbIsbxgebAp+SVXH2b81F+UpKdfkFM2lBt/ATD42P8IprY6fG
M5lHj7OxmxfNx/6CXds/MaEyiglwQaTS7PxaTcb/KQq3IyAgp+gS2VOw3KVeFsgDQVtiK7M1Bwca
qCi7dD04WZJUzoNwGg5fTAo7keGl39LaKfEjFDhHJ2rvXCz3TJoQn5HSsZhNUVYjW9npGgvbm4IY
T1H+0WYqe6849fOQ19FD1lX6petysFnMM+XHKIfPvK98vq4SQ4PWXnNxkkR8tYBc3jJvJgFJ83t+
DGY0/VUsf7ssNIciXf0r9T5FeQy58XYeb71h0/uufFRNj+0mIHR3P9ocxHdmCEaSW4E6LcrjW5Xd
8Mn8sex6kjF7t02j+dfvazvYWzBX9i3MACp+VY48iu0bl6yFSU7za1FkElH5bc1N5MbWYL+EkTAP
9u2QhW+E6zczYCgxGEd3bl0kzzabhA0vqSoWqF5oGzSYnDV9kSe29LtFlGZfZ5I5i4h5XyD1deF5
mtQI0kRcJ8otGTCX9myNefq+TMELUStr78Lnu9i4no9N44RPkjD5Ya3aZTo5VB3FPIs6zgtYpZvY
8Tz3nPP7QDBCPXA2wjMCJWZ0GDNE1bzTKzufwd3x26I0UbreUmP80aJjrkeBTeMqeFkdiyyxP7A/
UF2B6RlRVYL9CPp1LGPjiVBwehx+sGbq16hosQJVQfGBEdM9NT4M4mp0Jw8XPmhILN4Up4fUw+e0
X21yMJmbQPO5mhmWVTE6+KY5VMWt50HBKqWh1D00rIMpKysfCTaM8ZSF0XOG2MSRfspTbGFWgGJf
iCqjpwd6F4aK2j7iyTJ/p7mbf7zCqRlnh2/8hvPOrcyMV7VOoncrTHCrpdZ1vf2lmCBbSh45kjHP
hngndU3d9caA4AbUywl2xA8w9NOxpGJnC67OvcNOwUE0lPN40zwLe1PNbX6WBG34qCu03DrHxmG7
jDpgT7d6YqMtAFNvHBo0nhCogEWz9ylmBqbeLT0eh2lPI4LuTqAPND0v46CfonQ98l1Hu4425Bdf
Wsh/RGp/XKwBce9M1nnOzZlINdvKLhiKf6GT6Y01uLz8NN/qCl25fFmXiIK/MTD0nkA80ESZ1Jbj
Z8ULDSDXZ8p59zawjX1/k4QYD3FJPdGjEX5Z2qeoWE134AJS9xylDg9VB4T1gz1i4x+gPm1Jx0Mw
xVVzYViqLv58C58HWC1+k45mYtLAJJAimiSpRnV6B/oGV7TlWP8VCjyYmy+AFskZ7Nm7TEiOWMEq
5clmC0CUF3Eo65eylSWcy7JyTyHb5q9QqvZuliMRdMbhXyb35k9dt4/VLWHJrZtI/s+UHW1sx3K+
TVc9tlqlnyEc882AIvqYhNRHQ0anpdKkYF23hR/RRdklLS/1XPw2llNdeWHNZ59Jq9sYsDybsafb
56g85meGW0hyngQXQu3O7RVa8cZ691IbgC67XL7BaDiypbBZQPIxV8XuQi35csbZg9s6K0gvYApR
cVZJtgfMthtG+uhDzSlRgrGVR2xAADiKiohtUalXXWkOmxQCacxH/g2Zupp81wZ+zkPm/3dEPVV/
Eaciyo+X1HlQ05q6BBrYGQ3pAG1eebC5TN78QlwZvA2X383wqobsrUwS94Eel+JZIJvHlZ5DyOPM
//NW4Q6RO0+vWRFX9ZhxZE2pAq5hNmxQ+PvbZJH9mRN3eOGs/9XRVXrQBdhjEvVMCEikVBDU6hsh
3uQMfp26m3QRim2Gig0bgAXd9wJlJ9sGftdMd7bmyK/G/i/bYWrJQ88As5rH7jkP7BDqVJTfjOc1
DiBZ3NCiI8h30uHuq+8ZSnb8vqu+VeFkhxX3/bboBYtt2GbtYYFk9pT2U/fMKYVnSTB1018aPWg9
HlesBFNTs2rpfD/b8lyQ1O0A+NnpNciG/c2usOVUabaTBSyoXVQSW7WFv2NOiSK6JWcfvKwNakZg
n92E3W5PWCvGTKx37ZQrAg01UVW7mPptMI80QhRtqIZdvnaMsi3uKhq5qF4GWHnr430HNof/0TPW
sNUmItpqPros9dHxb6AO3E6wb9LPyZArhaIXEfLFqZzN8wTPHJ094HFGpsKxXt0F2cbzpvLelp77
yY4m+5qk3Z2iIQqmg1OVBwiRN/tRye9DPNzNnpKGZdheuvAXe0VyZ0vbGNaYpKeHxxDALnJ1Autm
nXKEx/ZgDawHxSSDl4pU9ov0/CyOyL/RyxXBQJPa/aiUtj8tcG3Wocrt4necBJYb3lr1n9LX5pLj
xoqAu1PTRQEvTljy4gz7NHDUPDnG/KEZgupOmLDfqilk1Q/3gUAH8J1kCDgut8SFcrzx4uZjh1Sa
jx1N1yFBgRypq5apwOk3/5fOGKNIS54Lm2B5y3SMo6r4ZPHCv2yMrvWAchqV9ZmQQLTpQqM/Cmj0
ZFTmhdX6Wqb6bSqX1zS5zQg0tTcHg5cbI7Dw4wWm0C4YwupE8Cx9UkgOX0Xi/Y+j82qOVFej6C+i
ChEEvHZOTu3sF8r2GZNBgBDh19/V93XqnBm7G6Qv7L32LXWjChhr33YNzpRyfOJxouQCur5nycBU
I7Qr8nVsdd+FkD/zuWhfRvgU66IwLiHuENBuOsX05ab1e8PyMFenmKEH1VSSNgQCgXi9LGDUtwSh
9D8YsCPDMiupOeCiDCWYH7gzvZtjuVulp+m3aXN2lwO/xa8/ZjxZWRWvLSUA/ZPnPH8pYuTPFdMZ
d08JFILnZhOOF40HHMFtVllMdNGVwOX+hT4xvTM/sfdhGfktQVe9+zSETZceC8E6e9cvnoeRByOc
WQlsWn+O8LiKJsSkmyG19X88vqLeV2zsX508G+sv25j6YekW9RjAfHgckZ3Q27WRwNkfjsUN0w/C
5oiazSNVKrKB9eawOMdND40dK490OlldaRy9jmmH4gZH5Jo7h8CtbxS9uBrPZhqn6GugzwsQSvW4
N1AtWc8Lstv5vzbjFVjI4rXXTJuQiQxLCtiQPNL6nM0hNy9fYJ5XT8E4GCAciypOmROkMPOa7Gd2
UsGtirba3wGk8ctHPADEJY/gxN5Jo6PWMhjgdqms6wPdIRrpfKiDBzGC3gs1GershpbwOU0KH6Cc
Qez3bDP6zTg24NlQTQyuGbbIHmrCroUVXVDAOHKty8rfZrlvb8eWvhu9IPzCIiPyb0fjmjKqQyLj
RgrKpi+JUPO4DlHhN9FlIcXY3mszef/YmzanwtUZHSDBHgIFtTNeeAtvyGNCCHZQS/rfDLnmA1Mc
snyqyPPQC8cu2kyIDiwgQ4xFZmM6wwTIhlXAWAeb/3rwGKrv/DBYPtHc+GYVeIt8NX0515vErmX7
MGrMo4TUdahx9arUPrhAv8vyGxnOodNLN1hdW9IKZzyody5gvPqFRZY1o865uX+/bJrY5iP1UBcg
MVAsU/BV0PfznysH26k/WRUlFwlO/drpmUq1KHmTfj7SK/BjYo7Kn6GZMI9as+sQ/HTsQ3F5pV4h
4UiBWl3j96njJzcp0iTfIK5Kp5bSlgF0dnBTx+MDAeEzTecITQWWYfSR6SscxTx+i6vBRJ8jJnl9
MiNyfvwrjWUQahtodM3IbUROobNHHaDHQ8q7mlfseFJjAedoYju7c+LYtYFTw3WC5haSAVEciyQL
JhKtlsXWZCy13VQRmaWzkhKOP8pRnUuBnZ1yI4mxgdGGmOyPbaQt/40lHJQR0EKWewo9RynH9pqW
cRujr6A/LnxweLBfuh2jZTDgXDzLFVlIdPOvkIR5jXLb6g9tDDqIEBWukxVNmMByp+xoU8mWVKQE
ncMKoyxzsXRKGCAjku4/i2S67aVKx9zR4cYg1SFfUIHhMPFWuvPb4jBU46J3JvKqT8I07OpoFSQV
CPxAw8bJ7SI/0E2TnSjnccnv4dzlwX5uAzc8TnDWYiSdNTUnQBnnZNyBHgVKD4snn+71GTQP5MeV
5Smtz5WOmeCgzSdsdAGUNF3xNaEcro2khXa42Yf7Qk+Bf6i6Ohp3oZUtLQa7xnw6zgCfd0XBNHkX
upfx0OOORI5fdkH33N1oHY24RTWieRU0zjclMMGLcYZJHlVDv8bnkeidgOX11WQD4hAPvDV3TeU7
j0Hqzzdmlkbe1EuSU46Iw8L52ClXpjvhjGV14Z+ULZGiLYJcjgNJpKml3zprDp4QQJnxhYyi/kEG
xuOXIoYGUInrtvu6r1ygdhETGeG0NPw+8jIK2tIeOdvT5pVioR5+B5g/vwTU4YZyWI6H2Mkw8N8h
UejeVZkq0LYM259qa9B/kYc/5IDnFUlriaT0njmimz94rUPh44bTlscu/cZdEfRHi+nqSqokf8g5
Dsq9Gcu02NVE3/1ISU7OJsODSMwFo8vkUMB1S7GBZvyc8IerM8AwSVSV5WTeZimUM/8xjx+uXdI2
wz6au/AHYpyNp5oERcaMrqaGlsA17E2ayObYeHnzXw9chLmSbZFN1y+jfbbZsn3hJ52u86SsN15b
0p9QC5FwFg75EBx7Pxb3I12Lt6uFKc6phv1LdaY46vnmc2/ntQUb4o6BAZYNbP8sMNo8uishsVmb
BFsGrSInkDiP5dK84dCRDP1plFBVCyfD0TIFgr7NkS5NEglt3T1JCHlAhJNCOFJKp/2OCeG4+L6M
T4OPlZwLeyzg3ogGO6Hs2VtugtqSL0uCrYO/AxcIUaGE6G6cQQQX8hTwSkkLcuDNoZMaRnilrDao
2/zirYKLPh6qYah+rHJCnDYwm+WZzSaBfQhA0Y+X41HFRy/i4AWGefHMN1qzE+jK/kTsR/AhfHq4
A0NABw1SbxAfZ3U47Lpa+dYupAdu9ovLkH2DM4Xu07U9b9p1SOAMPlcbg1+P5/szW8ZYnUsfOvAJ
EWya/Nd1aZVvLT3qZGuNbVseY+CMGaRYQtiwWkziGdA57G3Jru+W50mhNmACfAq6oWUgImJRrMuS
knA18mGCClVgxrnlRv2Uo9862xA3s73gVvwmQpGemf2tvFKVADQ15e0n1oPNvKK2auJw/LzEFT8O
EduL0KZycMt8QltcCc5tsygn2ONzgdzMSYm7uOfkfeJOqD5E45N5y9OLoSAxMJI2JIVBYuNKJB6i
5SA6miTLkpduZvS8HcBnDWvGB+5jBjis2bT8Di+Jgc61mVwvWYOOFXeWzmy8KclSXBpdU3r1DF2r
z863uu6VcWp9sfQyJvi3RpWdaPu8bYtTQ++ZrPHssQ6rJxCgcCI95PgXJnL2SSScGiKNzbeowhIj
Tbkw+xR46NgGzfAvb89cUh9b9oWoZ4g3E0gocffmm5oolFeAYXL+z4krAkFWlWCE9527BpkCpacr
DxSERq76zhZopmExp1dd1HwaxSxG0o88OUXQeCImSdPURP12HnH0rwTU03FdWpWZ9/ZoxfneZGHo
7rXFOMxpeXZWamz1TyjYb+9kqcaLQJSjvhXz5AJBQ9LpI9NxK7koAkXl3jW5lFRQJRCZkeHCtZzc
EHVTR8mNtTSHyidxDRFswtYN1gkzWcFHLU0y2gfWAjr7YsM7tHeexG9+cByv8a85w2Z7ZXeDWg5l
05Mx5jZj7R9mu8vDI7fFyEA8u0FNdUI/DIvGYV/q2kozXVUqeKmxRZI3BRQq+dZmqNUp4fb/I6iF
PQ1fdvdsdag3Nz2UkOXeS2r7D2Xy9DAkI1BplUF2wfgg7Me5hWawmUaoMaeucYI/dAxs6aRnZ8E6
QPYYnkgbWYKvFnroZgiRQGkohlQPVZndB51n7K3hJrboizDDCWS967lMg9MSRmQhU1oxgcu7FKgf
zPdNRbwkhwERyWKX2+w7n12Aa8cSJA7lw1j/TgGi6JXpNBoS48Nz3oqkZjSgvQFAYl22+qGDG0JF
WRlK4qzN/Bd+p/h58m2wcNzZkQ1mLibMKQ/DZnjKkAoe84Ut/w2iZt9jf08vTSs+7JZV70bDb3xY
xgnuCll47coH4rJtG3vBjm+5pxDIYMJBLVG612Es3vGj6vxpHmwfQBVz8LXDucsaxHIeAuhCNs7n
SjIIa6xHgQb9kjNPLdYVg76dsnICCW+5D12NaGtbMiY/IpdIIY1MVbRHNsZe343y6mOpDP7WyiUy
aj+aySou3ewiVDICYphuIz4LE8eL2EJLaxV7rngpC5SxC3akJnf+FS2eqLSauJGapr5VU+HnjRVz
z8/Q3oNoY5fqsmlVSJ3KwlllYwPLrK7mL+lWHeDdBaeKjTnl5DnuS8KoextX4Y1aZcQJ5RTUhqaK
PuDH/AfryAPDasZH9Ia8//mw8BIwt/UfJpqoK9jgiQOPieoO0WPypi3t7YuQx7AY55SciyoTMPRT
2gBfueUdFAO0TnOk/ylfF6da2ZK1a4FUcxtlRXWJnLg49GUu35qw5A5kkY3vqIMUvBpbHOOoBcM0
X3EnBNvMR5YMeCiOVq2OHKBpGIj26UAiNUpwfHN66YgBL8YmuMsEHmeQGojXDGYZNilQSlxv2fqx
x00KzOA+K1L5kCJ8u4SCqCGm09CLAkamaC1V+zNQbQwb6rb5xSwuGCQq8cj7bhivupS8/GLryXUY
TTVcFgzK1L7kEbB3KNfjhk+v5e6Y+xYCT62KqdtqZ8imI+tcO96YstKAZ6ks8MHwbjzzWhO3yGi5
UDsTpIO9CbxWFd/FbNgj+NbEkZsD3gIoUBFR+JKhjEJvowxsMrTRMgXeQeAbCALUY0cgvT5D6slu
vHYnBK/fhuajmj96W6X1Wix92D1MVqLHC7MWjB0Sx57Hsx+hbFglMZbUfWLdOJecBFCrFIMUd106
I4oAhj4RMkrbi/aeMuWNYUvKD9dL4t9Dp7it0XT6L0pwlMEOUPMtAIgThBRERPNgP5yYNJId63OC
btFLVIDKInLQ6LkHjmS3tg1peQzNSLPrKzQyZpYBv7yg+7zNkZErrbO0amduo0oMjK8gnqEwRzC9
qZ0keIamxSaNfz5/b+uG42wOI/Xlxqz51nCPIm4QPLzq2uOz5eudiObcTmh38XthR8aWil8WdEgY
9MMOuaX3DI0sYjWHciNB55erbJ8WlDxbzmxWlLlOoxBiboyyPuA+4jUnjxmqZ2pGWIwp6KCNVzve
fMAbNJp1V0/a3eNRdaK9C+Lo2EQAXhB2pMYwOmnb/II7om33umDHshW9Io0ikr0CkxJa/YM33PIx
QtLn3ypLoeTT2EaurVfAlgUpiCw4N2E2c5Io294TI8MkkSeJzNmMRGL33JGt6GDlqrv0F1QHGOY6
nOMvG4wZchPdZu0mj8qS7ZMbdy82oYS/y9wD0CbXifsewW5Dgx944vazmTB4WxKN94eqs8RR10HB
PbVzn5EiSACfu2vmhbwgWhGPjsmhcuN1JY9uB2hSLxsUsbSIyJMpA0n3NcsGbrcDn8/Nx+mgAFv8
OXyxXzVj3/CunnNrOnNoYo8mFc7DcEeD9cTrjZ81mLqQnVVE3AsVQZRZBNXIGx8A5cJThNYZ+lzM
XofnyS6OYwsOa236Ofq0Ysdy1kF+8wyhZK192KZz57Bq6NUn8lJAbVQI9m6gpSAIx0GNQLR1F+md
h8YJwacbzg0KjKEPmTfRz2x148FrckpQUashLGFomNZJi3PPcMRn8N342YGNm2UffUei4DOxqoAa
GhOG20lpHiF4JHJYs+JqXPY2VX/1cyTyN/foaAPL4/DjTHERFdd5TXsrqPHDDessTpxSCEJ0EnyO
Ev40ebhbPoemgEwTK++IeMVNnr0Qad0Dq/aegA2/8adPX7hNuwP26Qz7ogydaI14RPrsZZFjEb4V
9t8pF0m/ARUQ3EauBO2tU3THz1NWEgyJh0/7+0Rao7+lCO/c1ww8v/0iaLksCNFBFmFe4PncIEQp
i8uADBAcEoXwqZBW9zu5+oYyr6Z6TyGYPA8BhpGtagS+csg0U3ixpcjCCia1KeE0+Kaet3Jq4M0G
6AFZzuubSpWKVP7BHGaZR+Xgh6e5cuK/yR9yMqlKN/udU6EuFeHVjFKgvPC9L14Zkx+KnBJJUIQW
qGOrypIFztgnMrymZ4zrwDzC6opcLU0sC1JGkH0zMzCGSa1CpxS38lQlSLMwVKj5mT8LniKEt2q7
uCjpdimDaGeNqb7/YRE7WRtKldbfDFbaDw+MbYuUTbqugbCK0aeb7FEl3TlJWPkfVoyJ5zgXOQMe
rzMEvEODHIr1FOfDxYw4/DczspN6y4hJtesEp98VTQTdb95B6LNS33srZ38+d2j0ezCyKniE1Ew0
DdkbrT7O1KYctB3LFlBayAqhTg7pgbSC/s8emvzH6jNq4bFHRnl0MBiLg89t/TKDrvwDUxS3j7WD
UXalnGq5HyhiHro+9+/rRLGOiDlMgdmMjfWUzKqxLlXflt8pyfD/PJ0QANYqxLEMBhSxDOR/ehv4
/RJJnukJlIw6C6qasd2fm3iQ19XK8nvJQvE/uEbiF416/RgmM+K0HLPfHrUT1Fo7cUkQY2EFCa4j
awTvX3YDa0WBxEZSugX1micExSwuUPed4BadrymdvaeyBXC+LWqJYk1ZHqvNToH4eoad6ahNh9jw
R9n05QRR2OpNEDoWrAnHyPpd6rRvBUf8f07IPA4YWhp8YcUmsMsXeYJbHMsqIJIMeR1+YWMHm2BO
UzarGBK0qqLvuM06xiiglRZ3pqpr+SFbtjW7TEl5L63eewWTeS2a+QUW42OZ5dOjNc3kN3STuCAv
A/fTpckDltn5vuOpyqBbT8WxRIt7lI5BdYFgOT32ppc7LprigB67fSbkZ76y0F+2NHkkVU6B9YWG
0T6T08sR7Qxyq3piu3LYUzsR9vN7IvXLWHsj0oU8X7upG5wn3EN3su6RPhehdarDyd7Yvf+58Kxs
Y18/tzBrNjXsPeQJhNsh5qnZzzJ8ZCXb4qOJgtR84FV4Z2cf/pa4nZ4sDayAEj87pIgpiX4uoy8l
oSUlwrA7U8xvV3FTlhysQ7+bI09++XCV3q20vgGsBqd6rEVg37ljGq9RdH3FIfk0ECMDhWpVAYFg
GtJecDy9LFz6K41BAMCW1W3wa+QEG07Zb2MDmJvnwToVJKY8VTmQBrvs5kf0gwRkdBahQmHYnZFi
V+eiGPIfpRL4H3mVHzpiAR8sMyzvkvdyQycbYBLyly+69vnIFYq7IYU8+j5lmBcZ7fv/AmXrM1il
G++yi39zivlNEi7dOWrD9uJgSMIz39cHdFzD24BKjN1u3z5EbUCD3QGMtOxAv3SkxUHSwHQCXWfm
96p/eBijte4q59VGN7kOfekcwXC7B89o9y3OE/lvwOa27xwCglAhiEdH9MWr7+fth+uHtPhOgwHZ
YY+tOqt8Jiqs3S+tjacBo/TWgooiVZvvRaX+kb9SbyFJMMcrmUqcjQENHjeIo33jegx8UXHtY9AJ
OGC8noQeEo72c4k+lmoFeZiLEm1jikLcla3J3sACleilqR2RlQy7QUh98GU93kF1Bes7SGYAxBEx
S4wYMGLwY33B5OQIAGFG+5KPIVueKVxRMUePXC6yAm09B/ejFz4PmEvuinRpJQdzPx4d2yq/keRe
sZCoT3fAihOlA0rZZjoS0RS/NUW0s5ijffp0ROe5r5x9gyYCjykDWyx0/YEH6BHD8EfWcz+L0hr+
cAJiW6VtLL2pf+SY+wzqJXsvfG/cwKdlGuWAgapJWQTU3DNgZ8z1NmXA69MaAxANgL93vJZzAcgg
hlW3D9x1TIDStYQkZWBpVFvRROUBenD7SPwYZtBqDI4L9qBdKfQRv52NcERF+Ybgb/o23fuvM7KQ
T76KkdAF61nhzvu0CroG9BP1hWw4gmo8ZDVw/Ab8RDVpzwflpN7Bh8ZGwjewQvbMNZObZFx+K5HO
qP+12S2ixUk1Du/CshGOEygrWcgmwBHicWBUSS/ADTdm87MkHZwUXCt5l10br2dS+14Kk5IJuvht
8AMIZXwoXBaRq7pbcClgi2Moj1TU+Un63t9IkE5i5SudA/xPXPW1qOopVT5kgV5eWnijqG0qQjL4
OwpsY629JqNVv+dpbZ75TuSKKzvYC4zvzJh985/t2dFHMKKFTCeA923rV952SdDzJ4DEQP+im9nU
SyJe3LnFx+E7+DydmuRTsrCvIm8QYudg5Ba0nEH+Shui9qFTTZtyKcHjoTVXR5nALC8VggWvYQgr
ETK08DEfSt9mI9o3y6c9EQUyxWjy2Rc6Zza0euuNBBMKB81FAHD92MbRx+jD9dc0UNcsCbM/5p5I
KFTGCMAumnwXZDLYYDLA7kFZGDN2VfrHCZhbU/QSccNwnhCfNoD217iojXpqVfwBAq8oEUPoINQC
wrdtT2GK9KaQEe0fw+91F0ftIRmr//ek2DJoi96zwTYfOP0o39lZNSdO4/SrTKRz7jrzzzYIFECk
fWWecM+tQzr2SDbALoY7txbaMUA+6uSeLRZuUJe1+QbBFtb+0p53ttb1PXYVCBRFxy6lT7GMNrms
W9zSbOcg7LXfOs+9uzw08YPwpxyVoJWu7cF/gwabvDGDYQuN6O3Bssrsc2S68DSJDjNhBSa+BUd5
R/LAA8EF7mNpArHv5il7dC1h3p0SPa4uhL6RSW+0V0uF5zbMu30Uwe2lFnSxfEGVuMdbgvlXDmbN
mKd5aTwbQWwxttsmip01aCezY+QmHzPeCQrmlCREVNsY6Jag/ytiOGAofUb3yoImxktuxKFlNrhx
Sh1flzKE1pAQkIdUMb4zAQnDdNQEJKH1cr+xgeGsmaaeStEbOK0waJ4BrQC+QagxvUFTa5KNjGg6
V77Ntk0nrneZ50zdYWBknS8SZ7Mwd7+3EiUugCb78zSF7Qk7RfsedPSQUgTtlmHw/NUl6ROcSMS0
SfgIIffL9nyFFJV53apycOnItHauMeSLnfbn/uw6ituHa3An5eAexVxeb/7gLVlWQOoLx2J9osf9
HPGBjEE5tGs1JjRnod9HK4MI7CHDUXkySByeA1+LV607CTjehnK4jTF86lUt6YHPMvflIexr+0j1
Lg7T3LVEZdDhH2mbbMqOxvmUixsfC8z+p3ah+4nYNGy6WJrtgKZDoFTuuqe5qfShzqbpHdN+fQh1
DdeNDzYAMshO9Hlq1XIXdWzV7clKz13UuC+5E/LThn0eMVniC74xNYYHqyusdWGlL1MG7pDkANig
EmSStx5tMiKMATM74dlC+Rom7PU9ppHQWb30u+3jZiPGOP4wtr6HIOY/OdkNZVYFcXx2e5k+lM1Q
vWJcQwlbwjONBiJo2doOzVedM6dh4Wj/Fg75KrVuhk0XtCVQ6IaoC2uIr6R6sFQEfPxD8rb3DdRl
P9K7YuQBuXERopr3NagSekVU0jXjx8Hd9DNJbqe8Z1V1o+5vsjhz0w0rJNIbUWuiYbSaGSV27HgZ
i+hq2dqlTvbxxCyUJydf17lwZ6SX3CpxS13gLrL5TVOj9/6kgzc9mewXhTASC6heGx8v+d9cC5QA
nBndSpMYvM8C912P+FtX0eyP4wbDeXllUlKADPdt69nBjPI51MYgkvCteCcbP77PRpki9aZT2JJv
/JbqVpOaIb1HJE7AxzjBCyq+qSYowMOOkZOygTOHJc1HTJbCC10pcjhXJxsEiuGuq3xrn1RC/EX5
COnjxlwnDCClNo/9F4+Ed3xATvuMgrkDMBjPMC0I5c6qSRMITEwPm8NyoHIduyt+meUJnppFgz8H
DPfK0hwz4ENUdHNAnIMKN4QLxog4k+Hbdyt717iqvjaZjDJuEDvdJELQZyQhiQdN3FAedFkKmDmS
R5Kuo/s219235iq6jGUQvOLCGjZzotkL0Hv7hDy5PAhttxTRinlys44ZYH8XigB5tlHTRTBPPmRY
TK55SkzixnXt+jNns/qLsTLdkYHJpq2w9WOvIDE4RZr9KsdFCGUNt/ys2Duj2Mvvl2git3K2vLca
+eum0dWwSyIR3BSAKnxH09G9sp2Mj65bxW9zO9w3zaJPOofjX5N785PQO28xe3BszL2zSuFm3Fgp
AtpOSBC0KCx9Qh3Z/wt6M+z4/+IXK7TpiFuf5LkBvP4JzLK/c2j3MXgF80XGYjrWCff2WLG5YQrp
6PuMukiRH3sDcpnqv3Guh/saiN+d72MgQ+8JWN2ecBmWVf7L0p/TPUutG0rXtN/DRI4sM73TBC9r
BfU5+ccwq3igDVCf82QIp2mNqF8X47zhp2OA0RM/uFaaYjtSwfAQATwububwmvmQ578bC6kdvvxg
JG3Bl6duYbxpYu7ZeqiSq6NMe5+32sCon9pqRQTb+ARF0ex4RW2yF6zwxHA90vuAYRN6hv9b2lpn
6a9TmJiThjrSnwhKHA5EzFR3HSjQlRxps1awcTUgsrK2OHez5LPwBzKR8aLJVZlM5S4bEzpMpsJv
ft/VeGhzVrWAWq8F9M49qWMhcCibCFJ8IRP6U9BHBscFtpGVA33u//ETmDlcQxQu6lYsZVQO9OVI
iKo0jg8IDaPpSuTJIC+oiIoNwRLxM6ANQaUPNKmBxH+LJuvWJVzpXSfdjmSI8JbJEuZEQgun/w8O
Z/ZAVJaffZk55HGb6BN4/197J+NH6lz9wUak2JR8WOXaW0K5zX2uxYRJ83sI25SM0ClpVqMlKXU1
ym4mS6OnGCsI9zDJWu2nSPQ/KZf6/9cn4RcyQY8MdfiRHCHDdsHnUh0Xq+0yBrYReytWNCRAUt+o
YtuxcnyKMRv9xh041KKNJVi8yvtL/KFjJsNU/MKpE1krnzcH00rfHgNs9nLXTcEX5FJg883skjcE
VebgkrDHE5VStrFuwB+nZttaoKsCm5TwkP/BT1HiLlf4J9YwgLrzQlzO86ghQ2A5S89RNrX/0q7r
r3FUF7hy2+4z41Q6Yag1m4Ss1mcSQPJjhK/3whZV7y1JPZRVPlrM2bPqbejo7FDaXVdtI091V2HJ
5c2qEnmeC8sP0eYhHkTfUCHQY5oi+Up6ewcqPt3oyc9OrlMhMZsmfUUYah8jhtEfRZs7W/x0BcPt
uvfvy9zSaDupzOSjcq32I2NXyaHFCEXF3oyjZFHZYUJ9+dknyfwjnXJ5bENdPMxq8TkTiLYIW1s8
iF4SFW2q+t0jUXWjY+8/EFc90RRQTfuqt76tkfybyTXZIQAndtPt15/95DDCv8VUxFUqmV756U+B
9oNlQO2cJZmOq9G4GXZ8TGcgO5IAqhkEi8c4RTS1ghwpj4mRLkSfOn+6MbhWJiVZSo482blQEDZw
WvXUmk4ZPmKh1i84lru7mh6PSM9ip0aUvIN7gAzj7hfkDgyNvPmOEErzvfS5BT5iYeCfRwbXBZLT
uu4ppZgzJnjNp7A+2lxmWP6jOHXvBoUqymb+j5KzlG+GrilaQVR7xxeBodrCcPIZx8rcY1ken5Y0
0ceaq63GEEtuiCcxlrvgNBD5QnZg7zKGWyIalt1QyXKfRfH4CkdFn8m9rq7iFkECjcND9cp+l2Ui
LCnGar2IrpaPwAN0M+rEHKPA1a8wLJMyQ+eN49rkekfqqf9FITVOu3rQxAUiSRZnieRb7ByLjTuI
A0rpjl3eflCAkrmzvY/KXlBu0FeKk5uEc8m/iVDUZsJ4ZYkaAdSYMp8pfJ8Nv4A0hINETKZ8+Gjy
tl2ToeaJJkkQxs1LsvNQS73XN+r9E4NnIbdg4pwTujN2QYyjK5/4P9+3o21GnfTCzpHxk64CtoBZ
TmjbD+bF8YlJeCJ2aTO2aj2iQpnObtqj7SW6LskfUeA4JCnR5Py6UtjuuipZqNyh/e8bAMRp/slE
Eu0ToaTpssL2g7BZFJOPM3LmryTciC5qZ7IO78WcVy7utWIEjMiEHC0+bzMCZbKGECxHtIh6maw7
U944M04nUZp13G8EMgXFcxF5mpmWyCqWNIXJU8J5UgQNVdQlTyOypCswJZQSaWHhiQbUsgUhSOkf
uG59UGg8qFPKOuwR6omOPV8EL+lYWeIG0gyi5R8OBgxE4aLHU2cWsZyAWqoXiMyQ4Tq21lAUmls9
lgciDh+hvbICxk7FnemlQIeglRUW37k/YqSM6LGYgNWYGs8OjldeiUxXZBmFiS4PBjoYHPwJOhhW
UAX/DVS7vR9lj1Mlr4uPEbUqxSHuOXkTJxMOZxoVnZes42vJbGeB1gcAeA2Sz2GAxhofKS2NcFBF
LD+Nl4L8aC0gF9tpDu1/RW+RiYJpyj5nsAHoOBsFpZJfEstNn80CUF7l+6dxHILgHsuO4u1XgkRl
2wqs8yxMFW8dKepq08FIUedKRMGBbDa7PY5FCQ4vmDLxfcOcUgObrvlz/THYVZJMjFXOouGFHWy/
kEkDPmHXkqU2njNhe3+2GWhgyjRUd9AgvAfCWoL3hCOdRpZp6Esf0yptBRpk8n2hlu39qoFqE3HH
gvC0PqGe2kdAtYZxq1M14Q71pQi3QcVmdcPwC2kGgUf7sS3HZ4ep66+li1fyguG4JBETVUztWBs8
ECpm/oYxfEJ9izg7LpwZfW07PYNcCc80NpQfCQ36Oyp6khzISWW2Bm8+Lsw2gsq5Kh33nf6RMYOp
rD31dvSWddPf7ObZjhAVWj45MGH3qujQorenoMDvwAxcp08IMMhgRYqQ/nMHBB68DBCs5c/Mof0O
3enk4yddTWRuN+74SLTDuvaxikOJe8QteQ1vvsWIUhID7rvsfUSM09gRbg4gd1shuNqIQeLfA35I
7mLi7JBS4XaVKj84fV+iDQmHvUM6InxK2d5jbgkelWYQv46J54JhMI87DCcfKB3HO6bX9jlPVHC0
/VB8eFrHJ4B5RF2FVtR8LqqN7gpzE03F3ks5oHAf7Cj7b6a939uYrTHYwhxpUNqUEZtpz6ycIryE
kzPdCdCD67KxJQhRrGyIG9KXls2Zv/I0QlFgiFeGzOKNsWB4x9Su+U1iYR7D5laqxHfwhyBZIuUI
z0Ep1AN1QNjdCqrloG+S/YLadHJE+JSCgYUXBUChEgEalk5V+OsXD2xFCfUKWvR7FXZ/EQv2HYSb
+GuGp/QvJpSb/th4jz50w10Rq2nlhtaBtRjD7yrk2rZx6VwGKfCeyZ7rJ6ub18TynwYKzaMAsrLr
CIy8h+5QsFfliGLhdUgK7CV9FFu72knVKmds3W0m6PJ3tfGrMy0tk7jwyrIwQ2TRyjO44BhXbGqn
VIfjs1jK2VuFHSDjciTRtObE2TJXZvOAZG+P0oSmkSUWU48BaeLsf3bYI1b/o+g8lhtHEi36RYiA
SySwJQl6iRJlWxtESaqC98iE+fo+2Lx5ERNTXS2RQOY15w7KefcxmULMnXJDj/0mmyB6NCb7IaM9
t1GUr/cQk/hR9cWwmxep9/MUNDv04CpcDICiSvTNNyy/YU+uddj3rvuRzPQiWWffcpqHMAnHmHMs
9kJgSv9KyNQ7C00OubPY0uoigne6o/5s6+C1iIHHsScMGsb7XuhBQnfUlXORJKpPVZJ4H3jjF7GQ
GLe6NGUqWaCsKuu/eda/dps/9MAQ+lbbDkKq2V6cqMwOjvROxFbdneeLGmUnSo5klIsw7hK0xFrM
+3ro7CeEf/8i0vkCXQ/FORpfIeu4nIiWUCfufCFw+ZVYStK/6aBkE1veE376Aw0Spy1mWJI8J9wI
1r7WnGFMQ3Sx4/FJmSgqBdvvPCXMM7McxHumRu66ybUo2zmz225kUrX/WYSP92NbgwluR+LDF/Y6
pbfVkncD3wzorJa1mXyyvNg84gAcyX5u15ADh1gOtXPhhr2GQDGuwDweT8Spu9p7bAmBEky3kp3J
MC7iGoPlnFl3FnVoYvH2cKQ1RkZttPQm0cXf0uHjM/iLce84C559s+uPUF3Gbeen9TVyhrcAE/Il
7hwEp4yso2aAtI+cQyOd6dsyBZcK179KdDBuYrCDYF10e+Br0LVo7R3BH+WPPfiYQzMY3xqK8YZ9
rYG0MKUL3/N6JjN4FB1l2slvdgaJi+TFWLNJT//V1LhQRWDpR5JkDzSXGRwXJl6OP1d16LhzdCqk
wZ2X83N6TiqFyAEp4DBK08LIoM1QsgYAQjJrGbJlssClcMuGdmaxe2h4/1HvHpgrVYUArCEtxZWc
XOYGyNdAk9RKH1vQQ3sIU+2uDZr0LbGMb6jtajz7qQFDk5r0P3LHJlwZANYHwv81AeqUtW+jmsR+
6VixRT4dpxOna96DtaMuYG2MYyZV88QoS/Yf13qCUmnr8rNEdUubuX5iE0JebUfvg/nHrVMXpaij
KLuSxiBSLJQQa/qKnmd7Jx2gXmSmyp/8whGbwLeNO68bEizjn5YETnaYkAn/c53B+9XKJ0RjxfO8
1Vnc2ydMYC736X+qd6Obx1vpgrq4J1XgP1B3uApHMrqaVW6sdjgHH5Umkc8bFk7VwGUhZfynnAry
2LWiS8pnH6vsN+0l0fKgzXf8P8HZTJZmvlhLFX+kBgPWfmTLLTKdz0CQ92d25r/tqPVzm7Bn7kIl
QTgovk0/IgCSLFefKYNb2xD6MuPy2pZthzdq56SYczMs2e3ZLkRAio0QfrOfR+W/YQ5T6ygUF0vF
lMkhszveSq0Mrv7qtqsUDZKZJegccWxal2bqeAE2onzFZWF8lq/15Jo1AI8kf+OSxQMJ341OG49/
t0YUyAROE/xRr5Q3zPxbvB4b4cQVD/mi2rNTDfaedH79wkZ3xOI1+0w722TF3YtpWpYc174IVjFb
roa3ziAdV1a+x8hfDTipkZylTLzmNlixI3jQ98nSZ1NNH34b74OBrFVFy2aZnAkAe9XgRdvlb+zM
TcPIhwF6RXIkRMt+GNJMvucLCy7TnN1M4fHKajtxrsZoX3T5d28UsG7A/QcwBb2ZXyZ1MxpO8W9v
LOpCtQcA08jzGsCLfnSDwEGsT7vDnAzr36GPb56drC8/zxFXw4/7Q2yl/Suv0jk0xxoiiFsOxaf0
PO/HnKzshxQCaJUkrUPG6up/kYye0pRWTKjU8Nk7y017GRLDhJe1HVgISBavv3t2c1ADABPZfceE
krcYVhnNqck8jqLSVyyydUl6JbvkmDZjokNBpnHLK+SbE9wZNul0qhceNC797JPdzZRHpiFON33H
GpvSTRkixFYHoUyfQplaXY/mDS/oxevyiGpI3F9ys8rf+gU3RknNkidaqcY/rPO32uG5Ko2YzisI
4KPygwNc9r8o3gtM6z4sgI9d0pygZQrl+8TXxH2ojeQwzdTARqeKsl2PFL7rKhu0dapGAzMYd0M0
bx2hnA3uOXwVi0PvZJbQOgUDPrm7jqoXi3ikajeaXJ7BQ0f9f0Gjj/A4SjyWsoY5EzzlGb0sGZHD
oNXDQJec0xMTetmF41d8mIhOXHX1SaaHPLZ6Ndgs88CMNNSPCCqgpS9ATg6xrH0O3lWvmWwDNWqA
3juokdxhNeZHs2+tfSvd8llTHAzrdFUMs5IpqL7gMFx6t9jNjhZNPjqmU/+HIH97cFxj3jP7x+Hb
lkD7lGoe9JLcfTA1HElAO5eAnZtVDLctUX9TVk5/+rx/4QtkMd9ZTK+VS/Idr1X8cFlnqsGhX33P
m6J7sCklMjeKgGz76qsTgtbLRlvpPRlt4tReEK8aJ4eoHPImmG3kGi9trsGgb4QJnxuL9PPMfOEG
eMl3oKv6Ao+mDoc54bSo1/nxHPv40hlNexq8NNhNMVVEWXFuS+Pvuex4ObqTuyeu8ZpY1a1pOl6l
CKQTNI5YHkeOQ3eFp0lhaCKOjBtVjKl/6LU0Xug9rhIubrVNUnf97lvvzsqpywKOOWQ1i6MhkucF
k4c8Tl7vYkLUz0Y0PBU5uF0OFWaIYmOGjd9mvyZpAh4zfHEHEeSHCRkr5AnSgW4iqxSydymYojfU
c6qUZu+H+saG9G8WEyla1/tSL/1sBOUVtrzWde/2Es8YmvAA9pq/Z9O4ck+zhJteDI+XCzAU7l2X
utWxyxJQThGwGc//F/XJ1SVUDQIVlyb3/3Ad8E4LGJKDPTriQfJoPxgZVeCJz0UV8XIEZWKFhHe5
0iKZDuO+ifzx1RdxvUuFn70ygnBu8XQeHNk6fynYYNipLPp06OyuzD1gcI3yQ5y199g3FXVbLkU+
JZx5IrNTL+jqwTiPmGDEgnfmeujYGRGnVhr6bGrHQXyGRfwYGO6I1g4UJnfYTDgvFKQfCkD6Z7nA
UOST28ivoJT9vTOcxwasAUYXAv2J6D9BxSQY0kvig+a3OXBsCLdntyXHPVGKeYGMb8db1JXpdmqs
/nPBqEP+YIkbPE16TlUce6dSEFet0UM4y6OMwZGG2AfEh+umXSTOgYpVseO7Vh8gHnRUWwD8uWzO
wWmWpJY5dzKdBI2UH8o0GTdgdvxkRGF8cgqFik+HbEte8nHFR+LH2uW5IRxJzWTm1Xix5VS+uFM8
vOlWtI91Hpv7PlnGV4tZAFQ89KJz76FTiHK+FJplndouORsyFPwPmnXAcXJcy1WShacd+UBIWGWc
qmLP4FLz2Da9s1e99ScPqrPwh/FHc4e70AS0ePbSgpnwvJz+X8IPujjkpesRMGxbAAFptkTDgZmH
EY81ip7IcatLrGMvuxeINe5+FKhBJ8/qeew3XJlpeqJCbJKm7y0Mmlq+t9QoQpfd6CeZIksby0Dk
m+Rj5fIOyPtnKf0fS6UJWlXnHArAWuHkzYSTczsQAJq9KXS5eu0XDhKH2ud7UyoJSmmiTRQzAkSQ
vV1dO3OCiuPEDsl1N19+9ZC2f+ZS/s5V7x0K3eUhLniSEygs+S4jtx0XGDLPmSiNL7+pI7ak1iI7
OWK6pr7NMC/Y45aLaaE2UGZ/gfhStLR526yYtW3OFOeBi9OwbQdWZfjLg8VI1ns9d/n63NdxQ8me
hrkbM9ZGlnqwt0uQnUSVEplrO002dm6vPDKBEhAbJ5NtqvmjV3YNaYg6FQ9L9i6LV+VgWJ7lOGaE
N7qKjymYK1KLQ4IziMDAUEzKT2RPbMeTBxAC/amoCAptPWJkB/JrHeZmWnbvzMPQ8QUu44pzCQKh
Hh8lIS2cX0PpZD2PEZ/QdF/rlDieqa4LOWYILJ4U4VJG/3HaXu4uhWpzQ1vdPiJR6ZOCs/BKe1lC
GSEa+N5KDbCfQGJ5N/U4HvIkIHs58D83zT7+B4hShQGbmGe68V9UOKrjQpJ9jdQxDVuuA+3GDFZ0
D0qlrUJH1u6d0/twyScQZESwEPACbcW3yOu8MA34XJJ5J6bRjIi1dvbJYEx/TjQ2PhfcDn6pxBSj
ba/OJuBRLHV0SOx/TAb88oQwIrt8zGZgZH9TJqM06yS+vYE5xW4WI44+dRbENRSTDZpDfsB+cLKw
sIhvkOpPrDc71+/ZXCFDzjOwG/r/DtE90f7rkxLeJ7RStHc7HOV8yxnc3aiEsBHfn91UKf+RxI33
0BHZhWYMrbF1sX9nwbgS74Pf1FHWPirnBB9sfI9tB6YrwDmQMtzhTu2yKIIgTR6hymk5nhmpXzbp
oosV+2NZF2Um8qHnIHykI+Iw0gOiFG49mzotJDAibON5slIKW1hCYcFC++LUCyrC0WzxAqogSY6D
31K7TkF9u0Uf7Dp0GMKmPHm/OF2Rao8G9y1K7A9+qqsETkh3ExvZdYnk8lG5gAzrfiTY1tnsai5p
9WTlpg59PROszto7g6RY9xF853X6wvoXo38ABVxNHfQ9i4Y8SAr+IavNgMTNmwq6J3AWydOXT8/c
7fyOIE9j1pyUMobLmH4LmOlrqwtzJIp1ysjHXurzMFtPohHYQjYyJh+lhbz9jorspnYyTpHByHwU
yPBbk8l/8+L/HWj006wBUTIYjF+RUyrIXA4uUdCFnfZwENLm7iRIgAIqBMqZZvXe9qs1P7NU/IGL
eKOMxp67J730P14kz7Q9GVqwaLNDLefAz7rXgpvBDHV0n4GDUF2Yh+mR92/7PFHRnE90zx06VfzH
TNJg5qmBBjiwHeM+ZbZ1Hsi/HhFVy2OWDWyF2Kz14eMFOwyCGrPTIrBrx9llIqRx94NplwAYPkjT
wQQvzO8lNg667ZizLMAttmOBvpXYwfM8MrAgJ9ZHirk5+Q2jVETBjM+YVV/Yj50Z8W3yFhCCrfVV
9Spp9syMwg8ZQYZWnhgOHEK7c7kQ+GIjs7n53Wwfu3RccQ6sxgW2pk/gBDg9WXbBowqessC4j45d
71xwuKRkDTTcYrQnloBa8u7d2MORGZjW9Ffu6vzVMMAGe58l+8tQgl1ZuxH+V+1oMYdTNi/lxQR+
/iKRauszkQH0Ct31J13WI1TTzo8e9cDX9oatWxfhVOcgH5K5VONeeAv92B3uX9XTvynty9StD+9W
ty9TPt0z2xQ7u9XftIumZjtrMpfoQ5z8moVBSOjntGO7GPgOSamYOJuAQbCbuBkeyzTgFziZ4nca
guYcodMRbkT66/zizTCoIMYzOrpJKCyBob7paL7HdHMnfO1pitEmCyI+uZkTujALIEURvWDUms4q
Lv7C0KuYi/GauwX4N0vG7bZo/JK3bTaa9pbIAqvc82i/81iv/3IKWD4aLpdT2C1yekFr1S/uAoY8
o499tFAkz4Vhvq+o7JCdiT6MTTt4JQQ90PlJRiLiztBjVJrN2TNb/8RhwuLrP8mQ0DmCnc1ayxNo
hbmgnNxmFKPj6Cp4K+U3w9HWeMEJns8gVjwCXH4zHAlbjAFWBzGmjHvqUeoxerCsBbz0IPPPuSy8
Pw2rQnd3KZx3Jl5xBdpS+xsbRjTfIs2G0BazKqYsEjGIXSIJBJAOoE42bveW8Qd/tEXd7JV2Q9QK
ZhMXGrt7/oo2xzItaEPzFI+Wsyej9J5CZXsYfWhmaGIgtWBFZtM+nSeaK+Uo8u0sdf/r13jzvWyR
n3hS7X2PS3bNZ9co0zkJ4U5AgG8pph1h2bV8BrniMWBLrpl92SzdQZEiEJ36886kL3JMy0A+1kv+
H5jxOFzoFdORk+058brHsl9ea5hVtsYygs7ETo2xdH+HGPUwkDWJbA8LcPRcicFYFsbG88oWNkQi
1PrPeo2qtPgpCYSEQata0lhpsNBmNfK96iL3aAJ6JrlZ1B+Llx3ctHzykvRf7vEQoIlPLXvIqChg
Q/D+asZ23ccQkq3w1Mi2cQI8KVPwd2PAoGHVI6DR9OvLdz14OV4ZHG50WB6wHYmmvcG1/2RqJ39Y
NLX7HvUZ5QajqImCY0+Q7JhzS5BU3eYXxez7E/vJNR+aGRVYtXqfBoO4IN9wdZalOtTUmq8xpKG/
KXABqMLQn5CTA64fhV3f5DwHR7xpmxwWbfRlauW+l/5fyfL3hTUgjhyg1g88ckC1iowfAl/jvZw4
I5BrXaiDefVng5Pgs0e6sEMzaLEVnbKOtW+/WcFU1JRbiva/iZAORV6QUsm+SKX9TL78mTUH59yv
3ITI9h/9xhCPJAVxM3GWGay1cuj1SfSc4FLuWLi05Y48/cAkiHKCECjk/NaqwfqOPaLAtk9RSmW1
dWuUxfmmBe9sHqug83aiq8tbGWTTzqHidIdsKIL9zH9dbXrH0QCziTpdMDmbd0fItttrnYwvuS7s
xyWL+Lg6aXakIlmcOQvikHg2TXEolqu7zuEW64ih59EgmeC1xaDvoxTNn6GL3f84xwznPJ6NQ6Ot
7BIkw+ChdxjuAdqW9YOIn/w1Z4vYOyJ5MffVg5yKh9HVtxojiU59QHd8LNLivlQq3zPssY6u0H7a
BqPnAOU1WLFmtepUcuPl/7gV/GkmpXEVWOio279pChfI7nisI8TywqM3j0tYIedslqqCFjta966d
+EP4zjLjXnxaWd/uR24r2dY0Gb0Xroz241SxJ8aUB5COgIlDnM9T0gIFRb2qlxmoEYb0sZqsOKLY
MTjGyeBpThmsbsd7b7fGhAZjRde2rWx1zAZ+Fy8LBCP4nLnHzdiFPM1yD+uZGujGjhFSciqRxHF3
wcocBBTJg9VHhHcXwXOhHQGZCdbJUMU1FVHmgz3rJ8G1vEFKYPW74UfxL5FLcVLFKA28HR53lclQ
SDhSibv5ZMkuYKuCPZ/A4mkuxa+m/hdGFlDkRMAzpFvQbUa+bdlIi3r2NNPqcCiKv4GgVUZzBBt+
QEP6lzUxgvhgFeOhF8bRFmVBj696drhbkIen2ICgw3JD3CQkX2CGYQlYmCCWZ9gHp2n5oVCheoG5
TnmX8SDU0WaCSYWxuSe4B1Fjqsh5e9qbHhaKu2hBrYgQcJH8iCaimDp+ADKr8upjXGMfkJ52guVV
DH3ihV0n+y/dmGXBaEM5p7toIgq7pRrHl450hNLvUJWI3Li1Mq+SOe1zkOVG8MIsmxdKq4XLWsFR
CRmOtv9ZtIKfPTeO9GYiwLTTBAs+kx743iZPXOehjeaBCTai3/ssSJfoQM696tCASr2OD+LS59OA
fjLZ/ZC+cAGcnBA+JnJ21frlrjem7FMkdr53uEV4X9zHR3UydDNme9fs2SQFrEVOzeOpfbHntH2u
OzhVYJAj+QUIX5ZPCQKm+9ILF18J2kOdPGteBnUYREFT3aBuC659DEqr5qxpgU57LTJDrCJacu1T
Nh2bMc2cF3xNCi6OGfv9BiQKY4Rb7iHxPo1oLiPTsCiNMGazFN0sxZXCqMOqdWX4nPEnMesRMYOl
X5wqBIxT6cocxYNsJCHfWoPTShln9htX080uuINtZLNM3WX2bKt4mWC4GIchlaMZbSzd1ughZLUY
zFr+dCUzdRcXitEfuqr2vqhEvNxIX2Zd2EV9PL9xVKPJj86eVj++24tnDn2lPBSuH9FxVAhIfSn6
R6Mwc4vJ93z0Pik4183NaSyxHLADSLdsFgttcDsnQFeaDWKTAoGYwwCNjIhKWGq7vPFq5sCarTG5
xcTXb0Cq5rplcvYithswc147JzqL4o/rZuybE2YTO14RDMBGmaUeU4zE4hrDrSVJQzzstGRd6T5a
NVzeB0YTqjuXv1wcuQCNPHbziQJxZMEb3SQJf/dN7gOwAiGjgECOvC5m5ATelkFQFnxbXZu9ASXr
xtrx1Ek/OR46bCuaTfk2d7lqPyDdyYzfICF5+AT60EUZxnvLCm10ZkzMtE5lMsTTFaN9Fgz/ct3a
QtlPPuqyq+VujBRFFs0P/lqmwh3PJM+qHqSc4x8JgvX2Oz1fxk1dNkQPHmfjn4ypjnfMkFb8pJOb
XkcxcEIVeKghFJf8DMxmuBWjVR3NtVJSm8xSbYwGiR1Bw1sD/tBy3lHUchYpKxlHXzUn1vHZI4PM
M4yZaac0XDZd6r5ar7ulosnk9VE6/ptoPte7SiSy3RPAmYbvwtBB/J0xdz6eTXu082sxSHXSHoop
k0JdsZbSx45kshFH54bEkXknoD3dqSVCBex6zVC2Vy7Q7VnESbj9PBJesgnBpTwuJicl/7UIV6XX
iiZc9miWNkOO8WxnZ4fgeAOmJnFxybgr6wIBkTGHY2VmxH2tNs5JyTjxPdYBEwWi6Cjeq7JgLnLI
5qtBlHvAcBbph7FUKO1uxUzyrXUigxisA03LY/ZbPmTT4n8oRYJ4Y0ysx0dI8O9t04hdNUXm3a+b
6iRSb/gT24EnAZ3YghicTTvsEizgZtMU0C34u1lXimlXFA/04qxOD4hi7PSNOjaTg+1Qc+DBTumA
Jw4TL0MXkdwm1Vx/OV6sHE4Kmab6N+HVn5rYHH9YilKfS46imVB8K9QUghBHD+1iADhr7MKKmlPU
tzaRrqJfyIWbrVmfM/gckFbzWCG2sfhSTtguwKVhB9GZdxZ7+baUGMZ3Zijifp9NdbbGPJKUMY92
Sv3s0I2m+9BxFV/ujuUVTzmoI1ltaN8IAAAM9LBxpJv2KZkZZSBHxnrfxlIGE0BVhQgUarxaNFi0
/eHSG4NyETRj6T+a4PkjCBOp/V/NZQbkImA765AwsXVu0bQnkqa28QZdDSgBqx3KB/y6gpWTbWdh
V3ON621osmc/J6rfIiFlLGsXWUyswIzqdeXaqgDiOcCDiSnw6p6Grn3NW0ALYo35vjeqc4J/moqw
utE6rQHLC03lxcDcJArzaM29iZxZm7IQZ59R130dkZ3cdgqM1TUdla0ZV3Cq5NT4nBCOCp8/JLI4
vDldCiGtiWsur2vQ5iRd0A3kdiH9sGglfzj+9yEjcISKYiibT4GNdXlpLKJ798FbE4bDXNsASjus
TbJ9TAI9KqvwKV+nVMGZzWJzijGBqbSdmg6eDsgwF1V70tYaDDTXJM0+a4LkH1MZlv+IXOmVj+Qt
XbKggeW3VIItlHekyExIKl3ZyKtHJuZg7R08T3lzgjjBWcGu2DkL0NUdh9R8vk4DL9gns+5QvQga
tRdZjvU7LY+Jo1Jl9B+FabdhnpaN9cm5rTylnE5wnkXsQX8hst2/NXTME4wXx9uZHY7kwY4jcFxe
4p+ysot+Jcx+NHTVXOBlR2fWm8erTK0SZA5/A5dp497pyHcOlD8y/D2QoYI4Qc9FDLOL/4CO5yQF
4ACpCclzdUz2ROr7aecmAkIgGSqX+JjjYsDSWUzC2KIufKnKIFmnLwa1+BfPtYFxjYoGy8BngQpc
LVRx6MEQYBJV0nzzq5XgDA0LadFe0jLMcSnLbdDOcPPpXXKPK3iqbDPdyoLZus7ZJpyd31Mlgxv/
mvh65HfVmjOdk5vE3LI3tnKG5MDBuydKzPqGuHWkdU+GjzFL3Xwicwj7lKxb3AoTy8KZ3x3L9d7t
RFvPucqxzcd1muDB75xueDAZPakeBiSY6KfE4ePJYUuep4DpWLg6csVEcURrYq4plmlhpLuAMmVc
8Jrg83s0xtThlUMo5TWeSnmVchiNbMOKjVE8zCZ3HjBVCYT4ied+s+lLQ35yMrWMZ9PEJv00QYse
iDoV74pa3fhDKhcEGu9zJ/mUA8eTA2n2ZrxX2ZywAzNJsjze3My7rmEVhPlb6dLUkfWzA7F2pl/N
3XXnMaXDr62mZHFZykyT/1rhrR/K6LKQS3Fz5zMR6St9PfuVERKmyE0uDacUd1XiaYv4k/LUMO9I
yAV8tfiVR5cIoCR9zqYN4YEoFpJGQ26dfqpcXCZbJN6j0FyQzvAYS7Fs4KrM5KHaOF1JEg4EgDeE
jZjQtoMeP0cBNVgzKX89y+ePtQlBhvhZo0PmiyP0MZrt4AQDf8Di52sSmrNq44szcZ/e5qTty1vW
ekAgkLI4+xZj68E9HGxsPNvMAX7U0usNEl5CSJp1vk0TV/ZkcsFgBl7IoIM3fQVwSh8Ni9+evUM5
Ht9VNRhOtWMCq/8Ems14eNtwEHFoVvSXeGjlGYEgybYkIVaxwHP5wLmZ29FLtIBP+hvLd+30JFzP
Ck5Vlsp8axu8MTZosMQRE+mNISWv5YoEvHzGvWV2BzW3HtJLN7MKpBY2rWiojVvCe+61gpwH8E8k
VbbLGRBdqPFGvfFO2jM6+bKTPAzhVzn32q7a6Tml9Vln2wJMEW2xvI19sbcGq+mey2QesS5AolIl
EERQ+RC0Gh6Jo0/osfpKIMtmO3kGMmIIcZWAYIIdUWUBqiKre+urhTHv7VTHqXmbASmZiatYaVDA
opLVeLaC1aOqE1s07a4GMxJwjZajmNUuG/lM4n4xQF0wx83XgfvXnmpgvIsnJb4zuvcPPp/SIwvd
cmDhb6mnu2uY6MHtGEFEH+ihQBYuMpeSfYcg7znB1O3EDGCu6FoytaSqx29MoiT58RuGhx/oShfU
T21mAvc2QmZECjPr8+E5cRVmujP4VXEAAmSJOxo5GPtROtUhaSMDTaCNSgpybNk1msr80TPpmIZZ
ndUXAgRFqFtTHuOJ2OmurNGf1CSAT8kqkSt8MubHvHQPLBJzlo7F2PchwTpnj5Q+krnCCWwB5GSq
fB0mP8+vuemPNQH3xfwNktb6RagB7VsbTmDxP4dC+NXyhRG7pYNoE08D3PBN6pVYy0PhvtHndHcU
JxRcscq4mNSeOdShDdbGril8qwIOVxQF89eAF8jx2FX0Z5n6MdSwOpQLlyxeQHgOlWGf29g117Yi
/railPbmFUbj/TH7pHsgEL5AX2rqA/EEZlCwkTKH3M+s9uDGJsz+WqHbgA10E34ema1CWIMdt5qm
H/aiJaKOaumPd05wWf0GxI3UAW9ZLWkQDpxqGjHzFmi17/nbyiW7OdcTuXLQ//G2ZkaTDHNjzPkz
C9KLf9CKo9qpH9xIHP06tprXYu0XIb3Dkvkz6XkCDliBnMrW5HTTnBdYZZTCpWkr7gRLnD6TCu/c
Z0haI60wV/tcxoPEAFrDsnUzjmcAi0nHTF/FsecViBz3qJ3trUTMOjBEKLxU4bUuvB17rjVNljz5
A2uEG6XJEuZErPOa9pyJBcVmCNuUfdjIcfjrFqsPniHPnDvpA7zhSsr+lT20b3UaB4dUWE67j20r
8QlyCfe1nPrgZVD58Gp1QfJ3Aq1gfgkQDSvz3bd+iR2OpMxzoZ84tCeASZKJQEIu2pEXeQLnp+NP
6YMa4dQY4uTVULPxHyLRfA/izI1YnPAB3cLvAwF2jQDLPUdc1v+2ZoBYxLPAe4WLzSxSkY9qvhUQ
0h+aYOBfHnSCw/Sqq8s4dJvWtRlFbRmCUl5Sd2FpUQ/dulYxX4wMe5E5Uku/TkmX/AlIYFl7Mu5J
+eQ3Jo2SKKCbFaId81QzJ84RMenjVziVhjjPrq8mzj0FhG4AV6KuYH7nLKXgfODVmSoIHii7NA0L
ry3rQaWHVHYpieAWbKyyt0nrJHGtUDHgcbEbDGhIboxt4+Xx3guJA0bTE9Wg4JMmSPGGJT3qsMO9
PsnSA/YPGei+2FgvZ66kXnmOcT6/E7PT776p/QcaDcaMhOHPjGLb0EKD2BqHL+Yt27G5LC2aUE2I
infVY6px/pgNNhr9H2s3BFQI8SxYZvAGI4qXgUl4DN7tgkDGYx3UuU8gxq2N9jIxo1tvMeaxghLV
j/iCLFax6yt8rwM7TD5vetRWoG+6HeSjndbliwfUMLoZU85QrR3pifnkRg6BtauspufcFzVBHdrg
LxOY+216TFUj3hOX0boTJr3sX3tOL1TPCzuxdgFjMpKrdANGd0MbcgQ0Y8Dst9gYPEadm36LxGrf
hNuBucm0+VNkRXAmBtP+G1JzuGap716aIo6Lgx1olpICyhHIdWOZ/pZzv/JbnSXWLO8Y3qOMMLce
+yRKAu6GHIkvszA7+0rmuW+PjubfmMSWm26DpKKqVU9+2oJFtj3ny9WDcaJq34/vNNMCE9mdCyk0
947u8d/a5+V/K90SrRdXYqmDX+H2bvZQjCpDYbLhfLEowCuFoF3kTLxfLN79u4odYWsTQCA7ar2k
+oFrB2lqWvJcEaYsg2XIommzsCC8cNI8eV5GJnacm4DB81nH9466mQrVbOUwxZfEcW6EXQxFJJUj
/3liO4N/xpxRlokcf3zUvB6ebbnMN3aEveaJ4aHiv6qKkVTHIPbgPqRNSg1t/d1BqiWpVNFn3vXU
X4y7a4O9qI5WzIIIjPe5C5pnww3gIRuZgKC30Txz7HrdB87g0IskAOwhI1GTSpUjt4QNxulowPBo
xATki7/vOQJ5yo6DaFSpPwwcwcTZiqGhH4YclU7xEa0ZbrTtLKvz67J2ejVbnj5EGBHkkJHm5D2G
LtfQMa+XboevThMcKWWSby7baKDBiY5kVzfo5ZACDgQ902x4ZQXdVWA5fXjRBNBjgBRRoJTUMZf8
cmYvNYPsADxicmuazpDguVkKkTMbMlDKtD7KshuAt8w6ic0HrpED0b2CziYmulO7OR0JiiNE5Xx3
MVDj6cfiW6ENnTjvTvzw+to7llZFUyPuJoNlPF+cHE/mPRARTiVgYcGfeC9r+bj5CzO3PMSjaA5O
y5X7rxTrh0Sx1HH6n7MzW3IbOdv0rTh8PIhJIAEkMDH/HJAskoXapFq0nSDUkhr7vuPq50H7REQx
yJDtjrbD3e0kgMwvv+VdlGswmezLKPsxxtKIKe71edfjea52GHqzG4euotEadviw/TUP8FiPaUH5
8RhpqiyeDEPrqn0NNCzY6n1uprdaMwobEraZWw9JkACYxJYP4gnmPceR/Y8+phxs8csEkp8eYLIR
NmNK+zt7CJDTjZK0ekK/mqvcT8rxoWBiINxN3QaV/ZpCuzRfYC9kabAB/KTdAG0DRliiZwXgzx0+
MwlEkSFyBTB5OkYBWI5SMx5SUu83nRwk+zjHefRi07GldqNv/APHDlI7xwzqj3pTx8UOkwXnLudc
f4XvOCOeDIv3hoKMZhGzTH1MNhalx4ikepHZd1ER8BeQu0dkEPsFB8XORqvLR8ZrESKo4Swr+5Ot
q+mIQIEJZzbHrZBmntx0KkbqN0+q20aWifbUUAMB4dClNT4VxFMmoowUsnk3NiqwQb248jVCExBE
VOTmqRcxO9+6AJO7cjdksVE/gKaNsq95CHr2m2nbfYebIaD3re037bBNIqH5H0INghCTdZMMAVZs
YdhfCoQ9lLYJUCEzPkMCYkgGqMtNbgEflQ/GaCJtw6zB+u5iFedDScICGbcfopF90GaaFxlVDs37
B033E/+XW9C3QrGMoIy+7reSL2ofOVZ1i4VBJvTqQTZYIn/qLRrg+7gzSh0SplDqhnEUzLmgHeYb
WAiYECvmUIi+tOas7p0J/QNEKmb1kGO2ohgDTbQ+3JuUfg7zGxQuX+l3heDXmIOShDgQ82FCSYqo
AhKESjovdoAM3RLQZvsZX+8qQCJF8xty5pI5Yop/n3xKZ5lvS18H0kjCGObOW0OXikq9zNT4k/Y5
MFYqzwnUAu1GmLMgWUqmMr+kyxNudTOiR+GOXfOapGFubjO6QV8mYjHjUM0OMzKwaXxtSK4/pHOv
cbLC6jNqOuaxKvVuvq+snrI0Qvd1byO+ELyZuhhpZsx6Yv+kxjAhrzHeMl7SsHI+z3hFBMHeMGak
PEaiP+IfSk9Qx8Jy4zUvisB/6mDq7/HOQDm9SeaXTo/5+jth9EH3Zo6pHt64/YSIKt5lVd5+5NqJ
ATxnWV58NqqA4wkLJvxKiHG+NNOgaLikM560GJKbH3TNcgVkhKrv6ailM4CJzDQ/TtQH4rbFI+Nb
4XRO9BmAETpmo1UnWEk7vnzuC9+AJ1QllEThYH4xcKz3YCPDqSVftYLXFtUu5yMupVRbnBz3+9SP
/cGVunOPFUF2V+sL5J4mafqZBHY60v6FRelIu73BtRnNRBT+W/TAgA1MD5k11Z8hSkTjS+Kkw1Rv
it7g71w6pDQdSW1/tMyyF+S+jf0VSjXoJ3UlxLo8q9XNTMUM4SWgFtzOrSujXz7Kk/fjhGWjp8du
wawuae3yYHQzCSjafOUhjLqYoUxdofJikLRCo2XqhaHvaJvbfGicR3yiSblhgDDZTYrM+crIufzY
mUaPzoaV9U1/w+vXxH3uqqH+qqPyo70NUMW17Qzja1sSpM1bXek1KmCF0nqMGWQf/lTkp+lt3aMa
YWCMoe5pZvf1UUJQ7ndIzWVgo9wmKZ8c1xlgw1Fpadbf9J8smN0aegvlcwpmurjRlYKPiD4mUtnQ
iwfGq5aWBh+khsabiEZMH260uamc5yCuoZSSw/hbRpzIfyDghXhVBGdOu+H3qfKhHEQB/tghMmOs
gEZh4VPW7/zZcn7MjJTwbOYUvAWIb4CzSBBghk+h4aBJVmik22bOBndHTWTIv9wcAu8WEWWmxKj/
iIlkGGw+syZ0DJAYgglIu4AR2YtsNfwqKqagqD/ajCkHI7uxEOvqmCkp6gAkucCcGOEiVqtECxWF
zm6wHyQk7R4lU7mVTONewciLZB+TnSwTcjE533OUZxG3Qtcy3zOU9iGw4gnrjUORv2VtXTPwiLsp
AFm56HdS3YLo24ckqDB8O6RVENYL0m8dEWx8chLXSO70uIvaZi+mUmmfS8S31Neyc1FnbAPuHQ/t
LdB5lc5/p4lH+/QVnYOUxJjk+ckYO5HMG1MC4/olhB3z3ggsLsrEqLPNR+D8rYMcC5/4S4kS9vwZ
toAdoKcTZ2H3UmAf+MLsdgzwUnCCv1Ha7pKPVeWY6HyDVDikGu+QrFiBd8LV03K/YfykY0Ygo+n7
1GJ0HKYBU1ZooXLjTAEYbCUCSggGFIt6UhDED2UXFL9S33FpAOgWf4ZuYO9tp6fXtIy/Jw94t1V/
rqPR/8UIzym+D1wUuEeC6yY90vy6fs0RaEBCnh7gs29VtAYSZIK4Pwxn/p5oYQkpjsQOYh/m5JjX
lAQdqwOW+mCPYjimsyjv6nDw21fAPqN8XlQC6kNrtGgW7MqumrAV6XziiBnCmH9ptCALXxgxGawp
EjinUsO25oBrhf0LiyIK0dhpQ0ZLcbevXEc9VWaf3BoqqW4qPRZ/KWh9cOlB5gNHw+CmurdnA8Mq
2mIAtGaO5B6eghCAqKL5oBc5RVDH2XBGqdHeMX1aKjSckNUQ1vyx1oBZ7czMGr7kQTa6hwQHywkF
J9/FPEHGdCO2aLPneBISPNBnQM7fN8b5S84QDKCons/xBA2Cu33LTMpeJDDJMDa9YTnlKwM6Z74N
IIAmFD2Tg/AacbE6hlZfMzqaygfGkXkNJcfK5Y8utMs3R+t0E/meabBmgDca/2CbT/0HO6+7e0A8
6oh1jgZ3JzEAXOQDUgSTq9yl5Z8j9Orm/fxZtmWElJUYh88CPrRFhwl6qOgztnDEezWPJEsB7oS5
+8KAiXecaU6sEchcC3onBl0WnNws1ouXwC0znPcIcUAlu4L82kchxQOBSncxQCo7vSHdmsFhuGYp
twko3PxQdExBAzDIJkLp4AuPmT1aCee+r62voCuLuKXbEFf0BeYZ4KQ8mtANWCGeROh8BAEbPcxN
lhYIGzi99qGfnQFns8q1xdNY6a3wiGWQCKnC6m81JjgfEqGV/idVdpq1SE4Y9W3oG8a+gojh4bU7
PZrmxExWi+yHidKq+dLbzGC3dOKMn3RZiugNW4b5rdIUWRu1oNoWDq/1IzaJ0VvDFGcLDra0fjJ7
mEsPE033Lusw2NmifOoyh4pxJIJKjMXBHdr7yQfuBahJlARSu4lU5TK9jjN4jfsmUzMUliHiiI5e
hXAeasAmnV8s8DBHxVJat3F5QBDVHeKtnpI9GABdehiUx6QVtop3AeeTVDezOvUSD1SWu6abB6p7
OWkfSmfS4BlnS0P7fgZOHhyGGKYOfkqu1X/TEV9MXqdmTAKE6ERDW8IaXGgyEK3oJgcoTo17rcd0
U2wlvgaZtunMkjlM5WAKgqp9afhT/wwZIJirv5Woux7aYl9O0CihRbUjfcsC3Fo+7foqzFvxgmpu
jBG4rzHab14jiWDep9Yp+vEBoI5WBj9dku3Y3zM/44CB+R6Byx+cDrwxVmsZlN5Har0ZPw5TCTdI
EbJACOKIsQjUB2ui+nykp+/Mu64wim9RrRf9ITa1igGSXkmzO8RcZB10vRGCUL5VGRBOeWRcFIZf
w94kYh0nTESncq/n4OOs9u9//+t//7//+2P8P8Gv4kORTnga/QsRrA+AQNrmf/6t6//+F2F9+Z9v
f/7PvylD0Kq0FJIuZG2uRYeLv/7j+3OE2Rt/9/+SSZC1sK/K777dVtWOymc4pCLVP9sG9QRsP3ja
EOdx526EO1G91A6T+zFhrhUBT7r8a9TpjzEUTW5MI1w4nba7TFBPfwzTu8keuPe/Jjpwj51ulu4X
HU5Le2P02ZQdcFSBDlwlISnFH64MKd+yDKGkLZHvl+bpytjVua0WasNncsXkUGcT/iw24Dil7OAe
cuQP3Ufm6vKaunv6uBLZOenoJj1zlOAULu+niwKbopWkwHvjBDI0D47sbOQjW9PKNsxjGT1tBo4N
oblsLP2DZcA7RRHfclNuZ6loC5VMU3fYvxbiaNOmjWli1R1JAU6bCz5Rw/c6GeOyfxn0zne8IKOw
ub/8EKtPJoUrERZ2LNc0TJBWrnP6DAYvaLaCXjxPSu+BJ5XjNzT0+pvGEAh2SZKaL5NhBLeXV13+
X3/btVI3hI7TCl1MNoqlm8uu/m3XFnOThJZvFy8IPuJmUeZOdt8nMAuhEc/tlnawYr6M9ext6GDT
cWWbWmdWl6Yy2a0G/yGM09U7sLJ104jixS+G9jnJpPUSNAtMF5XEK0stO379oNKxDAkwz3ZNc9lC
vz1oY0iNgYBZvDQtlWUO8GMLmajed4k77mslnLfLL3b9OXXDZEOCN3Qs9qUhVp/TQrCnGqE/PGM/
CW8hdJcxC30M5OWi/EjDn7mRTXp8edX3L5RVLRr4pm6QhFvi9CnpcfCgDN+ei4QUfTNr9l9hQweb
qZk2/7i81vs3arJN6Yw5lo766TrGsDcrQYvNRzoyDx/0UidZlTHiJXDSoqUlBaXu8opn3qkpTV05
hm4ybVWr7WLCBLfpXy82QQunHyG779NCyUEPyIDERsWOyWQa6dPN5XX1c4/K5MXmUxJMXbn8sN82
j6WBIDXc1H8GguWVmqzTfS2R5Q1ouGC43aBWHw1z/T2z9c/m4tizTZoW1wEf2YqakGvDfhgo6lxE
YD6gW/Lqur155SSf+Y02VSetaJvOoxCr31iFZTA0KFg8TyY+JZsws+nNQZo27/IGF8goLarPl1/L
OuqyxZVBsGKz8UqII6dvJaRknp1QM58NDjjoQEgELZ0BQNI2Ys4SKamjaWuM8OGgtPsIu9zt5R9w
ZrcTNHV+By0u3Zar3Z70OlyRLlDPdjcat6nZ0E4qUx9Ebt9dWWp9vRMozQUXRLAF1YZmhjx92CAe
/c7JSvsZbTt3V0Ku3YPBpzBkpn/I4/KuJP3bQIKVO133kdooChAC9ZwdLz/z+4Btubpr8WMETy6s
1VXXYu0CmH+0nrXBNZC+HR39tkzTL1DqSfcLVFn7VEw7iLLRf7EypkC67jjc67yG0zfgzkPtWqVp
PoP7YAyqWaPajTSh9s6cWPdMpp7qbLR+RZVT3l1+5vff2eJ64mrUdVIK0BanK3NDOXAGGv3ZiMlk
9XgoRkSfwnkno6b/6/Ja74+RrZTAsc40OPGM2k7XwnkaA47G8Z8FcMa9aNyloAutAxDpdpuLMT5c
Xk9fzuXJxaTAVkpFYIORLJCSOl0wA3HROyJjyhdoenmHy2Esj6gVZ3+HjBbl3m4HcZthd4OG1BRg
d6dmW95OmNvNHxp0J/8qwNpLkFlF6KEvniMIFNVQzssyjB/d0HKfLv/g1QuybeDsnAJlC/4sdXe1
Aftm6lCN1fM7Y87nI3JhNfq2NTqONoK5QSiunbz360lh2HwRtHtdGrar9QSII2zRk4rhpItTbT7A
W0dJ1Efsn3kFEuPO/vID/hO3fvsiPCFwJeEoxLwczr27iqQ9cIkC/FJ1xxi5fXNNLTtwE+ZbOxTj
bSRn+UUbzAQ/uBE0SJm1yWFmcL0TlC83lmGMV+70dej5z+9RJAzsR2QN3dXB01PkVDoDNSXgMnkW
4u1Zy59DXPrh337JBO62DsdF4kek8SEHL4PSMPKoLyZGRY4ncT19u/KCVqXOPz8IBJIjJYGQocrq
PDKp00FLtnySIEv7LarQYBRM/JrYnFYsnrCRBENMXxYtIxwbJ7m3Ok38nZZGFO76zGTQePkXndkj
unJd13KE4Szb5fQMuUIbyPnHltNjmTfAbkJc15HWou0gfwmdftHl9VZBeHkB3AS6a9sAnQ1hrPZk
0uGB09HluKuQjc62ZS00WtpoyipG3kDyj05V2+NjTWP7FZfNvr6yRY0lKKy2KGks9z3vXycFW6Xt
TZdiG9OEzV04ptNti1UdwqBi/ORG9SO5vomKVvi0+Nf+zJZRDdWv5Eaq6JbbGKgesUxCYZyxzrhR
QKBQBtadv4MefaXAHuJNEgvKNiiKrw1XAfIShn0PYvb75Ze4/mgOFTMfDC1Ik6KHzurpR2tMpAwp
2tPbkp+O5Y1toV2joicuPrXV8Sx4vrze6haxHcc2XQtmtDCYhbv/BOLfkrjQqEOFILh26zhuL+B4
0nseGTNWAVS3TZpNXNtX9uUqtrMkxSiXteQ5daHbq5NrQ02g1e+0ntmK8qhoeOP7MSFX1JrN1raq
8QapxeLK5lilZSzqKIsyQLcNaxFyXG1OXPOmDLQnpgSOchgcZpDTrCc7ZVpyrERZT3v0vjTtdmz0
smVeD6xhG3cMfq48vHz/Q1yB4ojBVWo55AurD5wLkD01lC8Pex8x3DNmC9vnDDR5xsVtd80Xs9Nt
WL0d/b6dDNDoyZBZa8fpVfWR1dy3zFvFJxq7Fv0RpIRF9HWQi2UOWF4ENx9jMH7Jc4Ugh78TjNXc
H42J7uaNDmKfwBN2tXgu0WwNKWArkHLoWaBkDyq6DcnNygmRHtL2Uhe3DcpAuPtk5sjIdIoLbSlB
IxF5Q5d1PT6OEeD6LTQpLXiVA+rMbzHQ+vQDSTVqhOMwjp2xwUQCbe7Le/bdGaE0dy0pUaqhmjPs
5RX/tmcN0Hp4IoBQspuc2WjiD/aG4SJiOMZc/qSl4lz5aMvm+D2wsPeZpwlD5w+HL7cEnt8WTBqY
21iSZZ4YxvYjUrnlC96owZVV3l1p/1mGqtrgUHDTrp6rRLwlBm6eeUA1sHOmZ3hbmxK3FrOXuD6X
xq2WIbGID3gI6wnPkrTMmq0Kp+RKarmO5PwQikkLdIxO88U1V3f9mEjkLrEI8ALXHN7MKo32OfbU
Xo4hX4/K/KIAGRWlR7FbXXkJZ46HQVPKplGgqCjWr1pHl68oIx3fEIiFWzvPo6cMFaObYdmFI5SO
W9A+Cr9IfIhTmjEfLm+tM1+aSkayr8jlTfnPFfPblw6zxpinDBxlkOsAXkGDZj+1KIv+fAcbQNoE
1yQIXmGvcoV+KDqFITlfeoaYiLDpaD9Ix5+sfRAPwWeA/DgAXH6yM4eGL6pQSSRnQjZmtbniJhzL
MAtDrzGxxTH75g7uIID6DlyZZeCJcXm5c5sZ9WVdgP/mD7bz6ZmpRTK1DMNCb7BTrtExqYlvPsFj
HJM9Ig9YpaQlChtTXN4HPsOByWn1J1FXPy7/kHdZAZuZ5jgdJ2UvDeB1WtKbI9iBOsg8BFQNLNZH
NToeNJ0x+WLiWTpvKnyr5LexAbO3pXYyop1d0CvezI6lBT8TNYryye8MxFYRaqlnW9sw2LDkrtbd
wJCbglwy9uJoHsrHGUBS/1TpCqK/K5A4araZ37nyWORmDf4GQC3SnJcf8N0NzmUqabKTepIKS3NV
76MRiY+0QQvGAav+a9GKPbR9j7grsCEMAC8vtm76cI/yNvnDAkFMO2VdeIBpyJ2ISwLNvFTm+xBV
oR8wPBHJTpzJPhLUFMUoPpzz3gA1UC3uXP1riSVPes8/mr8YQGH8rXKa6AHjbL3c4+Vr/IjJYfUr
W/DMjqcmo+OuOGE2DcDVDpwKAaW3iTyUMGcJTBvLWjNQzZs1G07x0NKh+/vy2zkTN23eCq+FElAa
6z0/2rFBp11LvGFy+x3eQhaAWBV5MWFsX0qjuW9kgNdhGcRvl1d+twnwBZeoqBK2uaCYuZw+a5Pq
ODNVEfvQxm0WEo8RZOA+u+guA+T9cHmxM0GSBN+i+ILgJ2msni4mLbgAellhpSed8baFXrnVp+S/
uISIUwyOlGnYFFarbH7A5aGP4Dt7zZzQxwTfDHRU6BpGnkgqoaPQ4To0AYPz0+zm8gOe+46kZsIW
xMulV336gDOwHLc1i9jDUSilcWcUhxbF4V3osHzWwFmFHWVuA2MeDpdXfp8bM3FY4jQblvtBXx1m
IOxy6Nwk8VrHLNRTqNH9ucEZJXwxAoOZ7ohdI/4Wxej/+dZdcqnlvqfKh7Zz+sh1acqp1vzYK/F4
uUmGUttMgNnvxzG2f4340GGHERRQWuiyllfu/Hebd+mT05sXzAlppcnlc/x26YIcDyKnmw3PhkO3
Lfi7Ps6GjxJgLLIr5dW790uFwzBSZwrIQ3JET5eygHTk9IcMD1tnAwIexk4KxPkmsJvxZkJ5j4mv
yP40EPFSl1W5hYD3k7eeLlqnoPUnIZWXIt1xR5mFiBXGQJt8bqNDy+jjyvt8f/dyJVDo2A7tM2Fz
NZwuaKgMA50ks7jyYA5AjMREPI7/rmxcCLAwmTZ5lPH0ZY52ewjRA6KjsS9GJGv+cDcvV5Ou6D0w
HmBbrTaVaceJ6Qe+6TVt5R6aFmAnqhT5zqyV3ADUFa859LQrT//u8C6Lck8t54cl3dXbjnwUMUfh
Sy9tYjsEu9vNYGUG8vWNS+ruoW+IGLWyMnWsQa7+aWbH6kwqyTQM0h9i8emrN4VeE91jC8El5vCf
a4V3AOIfRfEIJCtBIiNooBr8+Wtm8mMTI5nh0Z87XXPW8HHMgp5kDusw+ChVfONrhfvkYHZyCBal
N/CwWXxlV585te6SSTLoMg2dr7taVWe0MQSt6U0ikwIxqqZB1ynwacbqITDay8+4bJWTEmx5r6hB
coS4zLl+TlfLUtXFmpabnlkSGdpQ5Vtm9vo+CqfvEi1D7/Jy5x6OOoB0kcSDC321czuIbBHaTxK9
iCnbtkaEWZ4AzpIjTnCl5Di3X5feqjRIl8mUV4l5pVfDbDJa8dIOkwghO/eoIda9z1Uub1sQ729t
pOs72pfoIl5+Sv3sYzpEJ2ouCs719KJG+QD52ND1JLrrmQO4eS6LLcI4Y72pYJX4N24ECu0Gpw2B
wS4GviYmEYE7uTeIYEsbiX4fwv6GfzZGIhOVvUns5xzJiTfAFb5xBQ1wbhMoZBSIbvRYCeOnm8Bv
fT+oI7jAswMGsQf7iVCGyo55TEkzhYl25f28S3TYdAtwgg1H2eSqVQ0zg8EvqylAWzxr25+YOtYH
+KjZ4+WvcO4jOLbQHRuUIjthtbXN1hkrIWrTa4uqfcFlKbtrW8SdomY2r8TG90vRvdClVEsKT4Kz
eiCMCSwNUQpFgtqLrR+2xk1XmUg9R728EgiXbXt6YJdGiYB07Oj2e8hLElhNDRlQgdx3QFsFqCAr
I2o/gQ/v9zRPnRuA9P5ukiX0GIEmy+WX+v6iZ3nFVBzUEaDkf3b+bzmFRGsJyYnc9abQme/T0nxI
SnRuabH5ONKDOjRCBAQur/n+JLMmwCLFHiUzdlZpI1qMmAJOi1wFrbpnMY+omKlBYtKo8kerwGu5
GXr414X24/LC7/fpkjuxc5Yx5AIzOj0XjTOUVQUYyLPjzDYfSrNBHx215Cr5dHmhc/tnqeaXooo2
whpJ0WtWX02SeBEiD+Hh313eR3b4Vgte7eWVzm0fXqO5dG35gOs6MwlbEU1G4HhlWGsA2OwWS8qo
ju/0YUAxLsmr/mOSquzr0In4l8Xd+PHyDzj3TpckggaNbVAErG4AatdS07LJ9hCOmp981AHxMaLe
//MYQ71GeuhwUpjWrLFGfaxMTSGZ4FlhHPcIm7aVc0hoL/5xlGEd7k/QeDSdGZKc7hHat7Mzlwp3
S1Cm35Q553cwiWpqOPHz8ps7cwxIdh3bAPe3/GvZRL8dPWWGJvBp1/LGctJufKFne3rc47bvKxy2
gZ6RY2O9bDEqvfLNzq1M6kfIsZXk4y1//beVmfMs6HBiDozx7CuKSfHOzVtIHtynKNbGKjug6tft
gJRdGz6dORn0Jhl/MZAEdrE+GUXUQycNO+WFbg4LS2O6NbVpsusGJzpcfr/vb0HSLReOJ8FG0FBZ
3RdhrPX/0C49qMOMsfwpGo6ZSVOFPjFSKxp2gZcXPBNLeSyHARH3Lv9ev1YNTaqyjAkveoCUcm/d
dpaLtEkksVEcinqnUP24vOS5Z1QEGZ2tyi6y5OmXpG4YKmTZpOf2SGwH4GfvTAPqglCFicRM4l4J
N+c+HwgH2pQ2NSjAmdP1EMSexSQr6UnTqPdwFuGGzjN+JIPz57GaqSzFrqQj9b6tEbXTWJWil95c
WO5nvQ/7nWONxZXTfu4koPRh0RQipKj1jM1odDQAEV/xygrx5MrNtE9YAeS7oC/AtluN0WwRYvwW
Kf8PEZsEFvoQUjkOMD8ToN8qR0O9PsGfj0RdB/abb2DB2p+awv1s6ECszRFaRL2UZX+8XQzSQdQy
lyJB2ksw//3gF60Kyz6hB0rD6tAGSbAz3cJ/7dAk2VVQM6MrmeGZ/Wkghkjn3uVDgjg6XRBxAvjb
A0Vm3zYmJtdRf2vkhn+LL1G6d63m7fLzvUNfLG8VnVcKSnSAwfmtzoOI68mK3E56aPq0WyuIUbgB
abiLhgFWwkhusOkjid5GbypKhb5+KBaOz8DsF2WHsBmuvPAz17NBg4EhEZcXx3P1lUd8FqfCHqSH
r23D1NzB4H0DJgWGqo0t5LEe3HLfQGM4VmCwnh07TveXX8mZE0vNuSBRkM0BSrd8od8+uenPjh91
tYETzuAfIqbp3ljVzU1YFcGVhz0T/6QObpWRowPwxVhdnagHSvRJO8OLM0fcwTFBELXr7E9FPEe/
JhVPD63sxZUof+YNgxkHAEBFsETdVdBtXUv1arRMLxfo+CIo7nYzthBIuGzSClvZTY+i4GPQonqz
RZpd3SlzCLsrT76cm1USz30KjsdiHsZZXn1mlCexcjUogCbMFr9GzeB/nPvQmP/8NIGbsWi3LmN6
NGZOv2WRDgjwFbr0dF8xd+mQMy3KxoCYDyFP5kx6/3zvuERfkCp8TULV6XrYFA+YxzL9qjU9+zlq
pu1hIq89FjAPrtydZ7bpMug3luqeVHINB0W8L9BqMzU9Qed2i9briG9li3xyYIRIl19+rjNRieQD
CM5SgoCdXz7nb2fCTeK5lyW3ZgZO/dXtqeo20P8wWZJYOODy6jr+lSXPPB+bkxqLQ8idtt6mEGJi
rjPH8KBuifu6sEqafQ3ifTbqppef7syJoJVp0Z3+z+hhtUuaCE83P/ZxedIXjI6F8MawCbAG30Gc
g+Et+/GrJgd7PyBpQIk5Wc+Xf8CZOABFzmHYxmkAfLkKwlOUqjzyS5iV4TBrsOPlAn1D8wbVDWPU
kScCuZNs4WU51ZUTcqalS7SF4QTcmqKIivb000JhrpqqCFPSIEtNsAR9dOaEjfnSjIE23l2agzxf
FCaPg6HH297Bz9uZQ+eX2Sr75vJ7OBMVGKVS4oJvZmP/Qzz5bZsloyaoqkVyN2uJ/oudAdgrja0/
T+Z/X2XdSe0RIuoQx0/uLBH7O8MdTVw/EIVunaz4pCz3eY7K2uui/BqC+9xn5mJRnCQmXLBATl+1
mQPkdOGs3w0wwsy7qUbF4dUNLP2FoWX6rR0FKoBKT9V4JWk7c5aW4Q/tEgp5pLZW90zcaoaNLmV8
hwJEfXTyxjjEsY5lRRBdu7//GSStIrvj/JPpOgp20DqBaQf+msTo4k7VqYmXCqhWTHuiLMPeoiu7
trzFvK/z9wEukdj6jjkA72NVwTeecY6GUHTlOn8fusBNMv1ZevYGYXJ1nQd6jYwZOj53stRxjTX0
eoq2gpzvI9urelTDPH65vIvfv+0Fr02whKexgNhX4QRSVGAJLcaRNhyzQ56K6KaysmanDPNarvJ+
R0nLpT2z0LBAULurD4tDa4vJEKy22K6a76Ee5Qh5ckQR9MlbKOehke3E5CKa+MePuAAJucHB80Cc
WQWN3i67GBtZ3xvRo6u5SevsoYvCvNiWScLI/vJqy//b6ZaiU8M4mL2rw6tdryahrOI6AroWXVvn
MUUJ7cYvO6xi8PhGPHfqunZrlAtMnXa3/+Py4u/3D+O8hYbA8yq6C6vYXMDpUAP2k54VZXT40m7a
1FbZQ7G33U0aRNWVFOJ9DFyqGyb9tBi5Dd4RG2WGeh2ePF7rVzRRrdQ4DKBYrkTa93uUq9WmMbzk
gXCXVqdiUAYKvliYexNJ9YeiceZHDQq5l7a5e62kObcW15qgbUOrm8z+NOypSKUleKfJQ2JoAXZk
qFAj/g1NObnWnD2zFIXTApnnMIH1WuVfMUb27YCcuDd1KvqO1Vb6IY+1dKfNc3xlU55fCjE9JoHg
TtdxDkOOUqB11SPPWYwfEBTJj0Zh5jeoil/DP5/ZgjAkFsgJSewy9Dx9gU7TY9XnZoPXI/Z1cGrE
s7NoAPNRoA84D2135dH+IUGcHjiLsfkCyFEM7RF9PF0QIrEIB9vvPewEM7w2HSu6ncLRfynMyvoq
al8/BOHUx5s6o3ViB9xjuzIzhqOR4jVDKC9xosVz9/JJfB/sLAIOlQtgJHpw605YVmMNZ8QYXiF1
gKiGMQU3qvMTL0RKBh2O8YA06B/SvGg6QB0EvUyjeAnn64S+y8whT9Hl9CT6vV80EM2fxipEOBMx
iL3e4FV3+RnP7KolNQBAAMHLJuys3rw7oqyTRZ3XIBPt5cgh39Ljn49KNfrhv1gKKgzABWptpnSn
S0V6N/ZhqrceMl0p5Xbg30otMPchhdmV8dq5pyLMmEsbZektrvYTBtwduldx64191HxwNN09kPDq
rzQ6nCsv8MwmUTSiaZxQEylrPfSM0NgoRaVaT1QjgvNa7R4HhaGqCuPhoa4mpKrm4s9LahpufC1y
aFAuVJynrzJwm9pRmai9YpiBm+xQO/GBoqW4Nma4U4doLeN/NoYHRvdIYRWuTP2f6LKUzZWR75lI
Qe7FvawDSqQzscoHui7F5bguwICj7zt9bHE7CG/zukKLjiJHQwK1M/10+8cbyZEEpgXUxLrr61k1
E42G2Ww8JbPxMOG6tY/QgDmaGrpJl5c693zLK6YMdcku3dW1hSnXmGAbRXa+6O34wv2Zz5F/A+5u
QsFA6/eXl3ufeFhMvbgdGUoxQV+jaY2up2wMrdpzOfmI8UNwn7DLOJZ58RF7oejYLE5dqPs0V87m
2eckDaAAponwDniBVmE+aXjzemNjRa8Ie6RfBtsKdogvLKqKZX1z+UHPVIF0qJdTQ+YLJGB9xcSk
GWXVlr1nwcICgBYn+JSnmIltp6FFZaapMSgJpshBWTKbRwqmLPgrqbXk26gnze3lX/M+XHCWoBYt
/VaQautwEU7omaNGM9N3q4Zghwfb/Oj2STUdRKMX1/bU+4+8nFz0GxZO7bK3Tg9vH9bxZKaV8PSq
wMksTpCB32FUJ98mJMRfXRvFbUyn4mRXd0l5BfH4PlwxFvhnmk1c5L5dHVigRvqEspLwmJFUW9XE
5Td9qKNfRa4hKuMuTsFWGzvf//gFA0Unoaa1Ap9qjbOMkWo1rQFT3kBHU86MW+cpz4xm5wRNdmUn
n/mWNDgBLtGqIgNcQ4icxqpC06I5NRSJ/JarcbpFMwXtQYH23uWnWt7VadYCSX3haJn0zwUf8/RD
BtyRi6T+5AUgpveMVS2Um3PrmIL+O2J5CzCg0cDAxOWIyESZXzlDZ55UAX/nc3IXUC2sLgEHNd5s
4ZR6pEzFoaEU2QzYkmwQlbuWoJ1ZCvQQ0xAAUtDw1kOlRmiS3DOpvBIw/I3uTulLhjsSBqh1dCUE
ntmgNIWYC9KcomRYz8tq2j8YQ488FcKowPtHrfHAvGeY1yMS/TkrOch3Ncel+OOrjHkrogo69SWM
dmd5B7/1gsDHRlMY4v0ocQcBvhSoSZFcq3netUjl/Sjdekj/kGwL1hm8jC1NUvqFSLVas8WSUGCI
nXuZO5TZYa6Ey4g56Xv3PjSnZNoVdH2vBLtzLxh81jJ0XZQd1hhO+oJlnzp0oucEt1S/sr5HqEVv
nE6hhW6XP3PNvQaBeH+78JjoSAB/WG7S9SRNHxfzIdfPvLqSzYM9N+W+HY0MElaVHQatuSYcsF4P
uPHS1VtYVTT1nHVWoneo6dqjY95OeloEiNNLTCyxtw2D7jFuRdrlm//P2Xn1yG10YfoXEWAOt+zI
6ZnRKFu6ISzrczHn/Ov3qfECq2YPmpj1hS3AgKpZLJ464Q1yRKVunKB1PJDLMlqQY3MpFbSucdWy
LCL40kaAzVU7nKsZndpdbjQ2Wtg9qrGF0CDC5Za7jxjgH0Z3Gg/3I9LNtcrhR+aRBhRYE0LCGhXc
1JjwLrnQA6yDOpq59VSMXxoL/NLRW+JafZkw7LSPoeKF4bFCNQTnrKxKxdNY0WM/RGjTxxu5+E2D
jt9Ew8aQ8Fm4UNAlrz+sSNgCEGs1B1lVW34pRHOZmKzuLGgzQCkifG5guO5cHKXo4aXiVOGw9t6S
Vv4IrlqZwsFUAqNy/SM0bnglhk0SjMB0Do7LgniJTw+O0/2j4mW8kaKu73i5HI11Sg/JpydNvV6O
jxd7o1wfgsgep+Ylzb0MdlI0YwR+bDkmieOjXZvi24zpWzwz8sQUYeM4ykf683riNwAbozXBR66C
/FtdTwjWx3homEOAQ57+r73M2besibLnpo2Gjcdd95BYigYkJw+UA1PdNSd1wehPbUerRyOvcPCa
qNuDTQG2cTXcfta0WpgfyjyCALbOGb3cKpjEj0MwDNX81GTQehGpwJQmm1TfRdzOv/81vfESpeAK
l6wsxel7Xr9EL4GfWWhLHxi8vfHLkJbk431uzFOO2WFuZw9Q3PQQg0R8i32Rdaa6MTlYx2pG8mRL
pDIQmwHDqatjZFepg+i4aAMOWYJFQWIWc3aEXgeZJK0dhK8KJe5xoMwNLLy3NJVuCGdyeR6dK4r2
DImO3KA/rsS+8AYHT/YlwIdL6N55aCjsU9/F/ik7oqbduBeX2Z/6tTBRyqOd7naVN+6aRR3cHz1G
K9rzuLiuccpsPVZ+KOjrVUdjQP38oKjIF5xaCGai2YmJdsE/Udgk2YvWJw7WHKUkQv10PYyYP7U4
lyOjGUeIcL73DYMq4ZrQmM/wmaxTKDP2YvC+gtlXXH8poh4n6A5Pm1bJYFMMQ3HpHb07GlqsbGSp
tx+MAR5XwvGIELKKv97Z1MCzerLnMFBVkKQJtdcusuf827sfj1WYDJsUdZye1ftrMA0udbMPAyzr
9MQXbS+losxhpGvYW5V7cm3A4QdnSnUTLGkuPr93fQAl8DdIM8DN4n5y/ZSRUxYTFCsvWJwQbiiR
qvH7gZnTEqXh37gDin0qst5Dqsvutvjpt9ECLRvKGVp3UAlJJ68XR5CvQtNm8YJp0LAHUq38Mand
/GXQ0HusXVa9/7BvrEcjBjk+yfuBvSD//x8fi4fG7RAlkxO0aY2lcWkYA16nDeSytlIoAFpRb2SP
b9ysyOWQcFCGSEzD+lKz7ZAEvC6cQCydpIJgdr6UlB/qzIzcqUMD8co6KhlkAKaJY5LnOYatOmpR
/pS2XlZsfE5vbQHYchrUfJ1SUOl6C5oMPQCG9GwBDhQPipi+IBZeH8JBTZ/ySok3sp03lmNCYkMc
A9gqKQfXy41F4nSYP1mBmJLcjzqIIaWY7YMmtMmfVaYL99/wbX4H0I2mBeW7LruLq/tgMtlLTGnE
Q1/iZOAvlY4bKQoi2t92GRaP9WDZWHzN5vAVAXhMiTzcSorz/d9weyNwG7A+hEVULm4CR24zSA6N
FnzWpJXnvsWsPY2jDI8GmiSFQOAwI9y9c5xLD5VxLrqP/FeWmzKa/XG0c4ZcNAlG8YCYnrfPmZme
vNIpjhD7t9QtbpMWlpLliaxPmIGt3qmh0nfGMkY84CWu6Ec0KEV5sFR4mocha733gl15MvqWsoBH
cUTOca6fTKvSCisjHWtmR2kDrC4Vv8jt9AeuxluNibe+VkBBtJfod3FirdXXUYUG9qFaj2ObZS1H
I8W/s7BxKmNMjOvAOJq7ZEIYFSE57MxhImHA60XH+8fnje3lxqGspkCQMNjV84aZItRq8Lyg6/vy
OI7WR3dekscQBMr7YwEZA8kLgZ/dXbd84syzFgsZm2BgP05uXqiV3xhYI+yKIWt2mcjjd8pNEnXQ
7eFSpftLEU+1ef0y48VEmn9UEEybNP0JxIMFM1+rzzDKug1diTdepmzg0WZiBi4/xtU51cWYawIb
hWCpWvoEdd2q/wurWvvLHlKcUWp40w/m3E1YPM+9+rSYSvIdI0BzIyTdhsBXChmHGGgW5Y0MWX98
mVW5dAa05TqYKsWlUduhm9Wk6ZNbNk2gUeGf7p+fV33X66ICyhopC4UUo2Kq7OsFk5x57YiGMm4r
MUQ2OkC5Uj4gSe7YXxbcKHhgI8zRJ5faNKfOM2vl04QfSv1ojWpa/xvWymw92PGs2J9GvFGxrmna
3PjbSXpbYMwzGlG8M8M+zoNJn6v+6GljgT5z3GBj5Ce6jo0nvoP4+voT41w19mchPON75Dl495y0
pm6jo2WmA3h9uBT6DxXDuH/Q2MJh0UUl3DlkYyLSF7coc8z7kOBQNw7+bYRGwJhTwVUB4YL08nqH
CqPU2Qh+f9xW4cmblk9MTKczg5H82M7gedUpnDZyj9vPmlRdCvfR85RTqNWaimLic22nqLji47iP
G9yb1cKycbeiCXn/BNw+HnAp0iqIF1R6DL9Xj5fMeREpeRZM9ax/MzGvEPsuddtpFzp6P52qYQKj
vDTE042Vb8sxZvoQdphU8m2DX71eOfdE3jR4ZgQ2CkATnHWhgj5RBP4tNEPSo2vG2EbWA9atCzFu
I3K+8dwwwhEJYHjJNq97SrC+6oZrawqsITcQ5oZLSCdhOgx0dp6KzF0+FpKIfX+z33ivHiMJJms0
X2GMyh/1x+fdA5Vm5o4NtaNPUX0eCmiDZ1UvI7Sx2/ffhUisOQaSm3LqzbzrerFYYP4wa+0QqLVq
HewWu3ASHM9fEmOrT3Wzma+gMB1tAIeygGHX9VIOms3zVEZdUIG1xEgzqw/Y/I3Pk1C1hyLJUsxU
0y1M6c1mSuwJvR+mW6DEGOuvFqWuNMcyboMuFKje0w6znp169ir00yrx9f6bk4fxKk6isERGDloJ
QCmvb/WE8ZzguIkvS9C3o3eYmG8952Pl+QKJMhTsnHQ/p2SPbl9Ij+7a3AhCt/eTLLwkkkK27PEN
WN1PaQwsCrejOigNCOsI4nsnsxgz9KaXJvqAnnG2m5k7mfwC/MT3WBHXOq4i7wa3k5yD/6Obz/yA
k7zWrEm9EgNlV2uCfDFQoeh6C+MDfMD9DB3bL/f3/OYylGtJ9RCDyTA9t1UU7C0ddU3kdwNrNkCy
FnhmJn7RIV96JKJYRzOqQ23jC31rTTDlZDoM1ZCdXgUlYaKw0dhhHdStVUXnKtei6avdKPhZl7SF
PjnQ5t87+JF7ajKqJBLJUfFaLzV0sklJe6umsdeX/7PhUO3sRdhf5x6Nj/tbettQZi2SCw4yuRWZ
92pPqyRGczHvm0DhDSc909mqyMQua7qWlq0SztrZiHQvP7hV5X0lUa+sQ5TGevtJwb80TPzWqMtu
Ixa/sekklkCuQL3LLuvqR6Eq0nWYWudBgq3bdyCJw0/q+0jxge0NJ/pSon3/a6aJTaEpdYnkd30d
O6pisRylNPKgz/K6ZTo9afE+wptt+RmaqfnN6DCN3MgxdfmNXscQ2C60HyFNGBzpdXGipqMRW7TJ
ggVgR+74Cx9OXO0s/ApnRExkm0yPsmpGGNbAqeijbRfJeKzxZ7Oe51pHzKaz5rH8R8Njx9hVltaJ
V5/FBG+f3qYL4sVC9frDGHkemnM4gI2WH1UYln1RnWlqzvViV93p/ol6491JKVxyCNcGdLSeUESl
0TrFVGegcsv4XCiWfk6VZjrolfW1cqNkY/pg3u4h7WJKVgR4pQbPKg5WeV5qVZy0gcp87yGduvZS
OPNWH/FVEnX1qqD3AZ7gSuOmXvfam8hDYWupxwDTlcEJqHALpFhUzEWOtesw5A4VsPz2flLwSPhS
o5eqPQhyNTSkjaxIf6QLRiMveESP4TfaM170ITFxf5v3llcY+gErQYHTX0qmLB1bpwpLNmwz7cAa
J2I6fFAXTfi5zoyDFadhdwJlHytnKKN03IqmqGECAjnQz3FlDho20JVj+emSzc5HZG1VFHLCzFt+
diUetXhgYur1q1A0NTrkoW5Wz5GnxfEhQ7Bj3MUtnkD7zK2X6Vtmmki+xLo+/Iv7RD4/L4XW9Zds
jhQDmVojWjTy86golIfGq5Eb8jUdWY3UB9dhec9IHoYu/cgZE6L7h+z2qmfwQa4oVZchTK8BHWBZ
+A0UAUGHmO50bit9wqNbRHG2gzLT/u/+ajeJKSBhIAfkwqjDcQxWiQUMcjF7DK2Dyc6cOtojJG7W
LzjVO86pmKc4/V9Xi6TX9i6WZc4hnrBW+XT/J7zxwMCyIXzCVKazsI5PythkwJHnmt7CVHw3oFR8
b7CcwfQUY5X/j6Xkl8TEBybH+sbzityZ7bhogk7JNe37AmFi/KGkZKj/Tuh0mR/vL3ebKrK1cBNp
Kb7qC6562GNfJxVAADvADK59yhu84GC4BpnW9E9YrmY+6EFrI/K+saZsHFPWE3chc62ChpmAUcWT
ClPYZi76vd53erOzFTP/OohW2SFO03+OPExv7j/qzUuU1DGwD5KSg2nMupgnrbEZHDs2QLbCfHKw
u36ImVZjZ9lt3es3Ufh1KXQEIdZKbt7qyDZJFLYIaNjnNlLqv83WW5oDLpvpi44YSpAby7DxRb65
IEFfSrzTjF/DJI0yaunTK/bZNpdfIWrXTyNmXXvNXX7nuhp/vb+Tt+kvEoIEfBghvEOgAPJa+KNw
wpdmwV3SMc+lqqQftd5Sf5g9ycQhSQs7Qj65KLFJTsYuDHTF6TRfDRGN2uM8qx/u/5SbQsBgvEOr
DXgoJByu8utforphK9zW0c/jgM/u/5Q5mlvnkLvumHSP1WQlQuqRZerzkgBy2dk1oL9jkhr5+P3+
D7k9XR5FM6oactblwPu5/iFe3zLAjHFbHZdW+MKI1JNutcVpAEsTvHspykfp2cNxVkHHXi+F8y0u
9hVGoPjduiVtmygz7M96I+zpO2ma6325v95NAEZFSUr/gNBk/sIZu14vYWY8T6rSn+zEHg9tbke/
5g4vKVo/zSkyK+jabicuplnF+/sr345I+YRwEgBqgZKIdjPyyIrFbZC46U6R02LbhqjIpxiz34ti
hNWBLar2cFxR+NGcDqCz5iCZWC6PbavGgd2X+MiZ6IcCTMj36NMh5pVXZZCh7Exh5tWYnQ699dGq
RhGoIx6HWdjoz6aWOBsB7+brlE+BsRUEcNjujEKvNzAGriJM7A5P7JN9ieq6DrJSTXYJ3g9HDM22
VGNvAP8kQGBCEFWlFgeasA51JAN2MVYJoC7TjKrjjLsBI3Qj7DPkJpel1sXnCaXR/qFxwlR86EHa
Z2QKwHkeXbw51C/eFLnKCVtNWm2+gpiSuVXZvWaiVzkdv5HwgZQCZRZQ41WMVNAItrqpb04t9gwP
WjvrftNEjd/WcbmLRiX+Zee6cVCX0XiaypAiE52HfVcnONtWSXLSetXda6bAiyqKko8YcJvH1rLq
fbuUaYCaf/qI+yAmoGglf/W6Sj96TWztMoJjUEWt7VvYqh6BjChn7ILnjZN7E5fk03F9u2CWEFxb
y5Ah9IeAUKk0p1w4xR56Vfb46hdeVo2+D9O+e5rQjNqrXd89MgyL3hsi5PK0mxDfkQP49QWUNhqy
xFPUnvJyBnJax+4pauplN9jGVh11Gx0AlzIVMEhZKAXWhFMNjt9U2UYS1LnqNcNeSxMnPI5WMyVH
YynD8tnV7cT4GYqoWP5eGtp/7+4Jw0Li6zKY/ZDIgNFafV9WOqpZU/AT0my6RKJsd/iGtk/WmNcP
rc2HrnTLcr4fm26yGLkoDwypSwb8tbj4iIBr49oiDbxG74Z413QojaMsbpfOWcVeZPkn1fU8SXdF
ajbtltL4zXWDEBCnS45HQP2SK14/8jw2lV5qanhWRrTAessB3z046YE+U7pxlG+XopPIDI8mjk1A
WUuERBQzdpzP3rls7exMC1H/iIKGs1sw4t24zW8CJZcMjW8KPdnfpxd9/VRixv9YdULvPKWxOKo5
InHuoNsX+ADfmlRP3zveYTl6zczQSI7kPPR6uXQqcViKoJRkEOUPKmrquwwxtbMS4Y+lVAgU3z8y
xmormaGDKCDjfR1fUJ+ssm36mGpoGqPyaAITyUGHlvX4mGM4kx6jfnBr2oe5gyAv7TTR+I2jVsVf
uP2O6inFH9K+uKOpoi6LPwlCszAW1SN5dL/8qChK/6WkxKQ1WSwwywvla3Iw7dSeTxbQgKXd4zaV
Pk5jqtpHbarSyPdQ/q93YTdNM1ZXSzgpzx7s5RdUScz+nMzwFXcIcTPxMEOQDWcnqaxpv1R1KE5x
Fzo5JXiuLcYW0mMVUGDYgu+QlgcSuSPL/eu3MliYztP5EY9qZoSnpmm+DZ1lfzHCydk5Zm/vk8EB
zzMPW32v1RfNwhSY5G/QUsk0THO1sEYV+9pXRqpMIKShan/DsVEOddrpgRaZ41mKeRzvH4k31kSQ
kxhtyIOPeMv1w2KVHFfW4taPk3Dts4jRKyj6yr00iTkjMi7SPfC7LZrxa1b8x92LBDhCqywpAZuI
V64LeDFwvVuNtVxo4JjqYRjcRceWp8tKZmjaHP0um3D8q04VAzvlss3MnYse+SeBuTECDgk8+11d
223rz+iFPpt1XTTHMI8c50lUwv1mLY0uvpdJrmQdkRgwH/LeWWRgUJ5Hc42HG1tR+Z7AWPkZnawu
2Q9z57hf1Fpzi32tll310XCrRfvWjOWQPzp4haW0VMI5LXdFBoY6RxTX6zmJUjBeIA/Y4FqBscMI
6vQTnT30OnZqbVdAdJzKm+q9Jtqi2ff4DV3aFu7akXsk/T5UyNT5zM3HABn6RT3EXJsfJqh0v1Mc
7f7nQVB0/RYz7PdFOt4ApC55zgCEM1Ffy9Z5DEvaCSLqpeqb+ZNVLeVfnd43F9tgmOlJJbv75+wm
8iCQJ10EAFFjbkKpcn3OLFQ5Y0He9FxH1nxCdSx5XJaoPIEIXk7vXIrLkK8IryAcYyRV5HqpJQ3r
AuZs+FhTjH5Wm2n2UzvqfmTTtMVmeBXv+fMgg/WgMYPUxqv6DUi067XS3K016q72QiApKVAMs8sf
LH1UfhpKYlY++EdA4mNieJ8AH439TkGpxjs1uTN+dTNdpFDbMAk5dy5tXuhBKGLUc6997+ZO2wIt
v+IB1z+WUgpeAIwsNknefn9UzR1Jp4pmRHVRzbrzdvXojPlOQ7PBoS28RI95HhfJZ5RfnL/G1tUF
3LtK045VohTqHsnPvNzHs1mlfrOUrvGcRKNzrFRYeT5pvaMfOzt307Mxl3W6EaVuQrIEfgCAA9wC
zpGk4/qXL6KkYV0PxqUuzfkHMITqYRgMfOlVIwPrCLF91ou/laSpNrph8v39uWV0iCCLkMpa0Njo
/q7CY5G2dj4W5nIBcDNcpmnKHpfe2RJ1WyXrfIyyEKEnJC0q4frIIP3Hiyn7CvvJtBov3ZI3+9St
h0NulsveWZRfdZXlZ62yupepG8cdXL3ufP97WSU9/61OHsJMmF4R18/16lY0O0CU9OFi9MOg+eDr
kUBMXeuEPi68glA6rd9f8a3nJf5LOg7lAciW6xWnuVhKpSBVxqoe53TdHQH1GKiblx76nKLO1Naf
8m7+oArchobZ2zpPN9EIZ2OZOdPok/PpG0CFhkY93DTt0lrLsFdS2/appf7tFm9LDvqNR2UOIsMQ
s3fYcasA0cG3TIus7y6RImqMJZjUqKYy7ucBGk4KoPSoqUPzXEzOD2+yt4rcVw/N1fmVoZ7BJe+X
4fhqp9tSCwklSXepvab4VotJqQ+g66Pws2GMXuYDWzF/OdrSJP7QmUPpd15vesiz6qHhy5xB+yIY
iQ3nuu+Gem/2Vop9h65850b0ykPeWf3D4nUYmNlaLJBWaxrNfHSwT2d4xWggOTj50P8yC1tNd4jx
lB+RQtXTo2rOc4Umct/kJ3uKNHvXd1P4TkgATw6rnxoFh0YA/jB+rs8ZnL7J0upGvVh4uZ1yhEX9
wQmHZ2YZ48aRvv2IiN+SkSg9/iD5ru63ph00a2YacCmd4d+ipvgPR2G+ku0T36rU8p/7n9BN3kZx
D2IETSOpQ0NIvH60EJjfaEcjGpOZbv474UV06N3RE0crNp6cXhRf9WqJN7q8r0SP6+PEqiCg4SDh
UXYDunZmI4yb0jMvFhLQ+6owReCl+W9MgEBllcLZWV2dP2mVpow7R4oXL8vs+EDUq5+FO7ofGz1b
TkYVbYmcrBvC8ozDPwIFL2U6uPjlB/9HBM0ZY5cz1r4XU7jTQ0JV4pf63ASjncZfRq0ev9MleHHt
xvoQkdU+hrFlfb3/Rm5jCjcUoxngpmgfwqi4/gnsQ5JhDW9fwrpfDhF2OoHoR/cgpnjZuA7fePkA
T16xyhjJov17vZSwBtcUGvWYEabaQUV19NybE6lDhXCGip3OT1fByfb+892ecNA8r8K/gLTIIFah
pPSi0VuIcpfc0xqUabW/5zmMn0343Oc5ToyNnuUbz8h9JNtHaFdyMa6Wa2BOhBMkGCTGreTShoPp
x8Cj0L/L6uPSW78Lj+/rfY8oszmYbLijAr2QaNPrfdVzBA/sGQJbzF+efCz61NX2LWy1X1UUVdXL
KEbrnaMa6R1L/xE6IT0ACXdfxajFnaxhsOf6EqdD9oss0s33StNVT16S9C3X7zD/fO9TcvNJvAet
e8gja+ySA+U2m6ewvTRDXT7p7aKe6bk33xOh9uhFGltqHevkjScEZUJIRJkX4sBaoJq0cdDLHHtP
AaxeUPBrcbcXrpGHQdlgvOXbCJJ+tZdK2Y16v3x/99OCZ0T0AFFIOixr7RnXKmiGEQEuiiNGDQKQ
kgx7r6+86GkaS/WQZBY/5N1rSkIVKDsmQ7Ru5Nn+IxpJY+08dCycy+as/DaNVFixMdg/41gPVT92
lfbT/QXXsYeLWI58ZMeXEuOmim9Nm7tXV+aLZOCeM4b9x8YDudln7VZ1tQ4Dcinc2WBTEegQGFg9
WxV6eos0yXTBetE41KZZ7srZU0+iEP8sNEE3wsBbT0bixGpg+iTL+HorJZxkNKDCXwo0NqNdAwO/
34+R2f20qvi9+p44r8ucRuK+5UAP48/r1QZvjk0XnPcpm5bx4Oj59xEi235Awe8xHXpz4z59/dT+
vE9ZDwoVWRRjWsnyWQU5l2xkBOFan0ptjGAtUyfmz13vep0P2CuDtaXH1WmqMLDEIrowmLUpqAed
c3hHn3Hv9CLUJasi9esqdyHFtPr40dVS93utNK3uhyitflZbTyl2Ra5MDLmhUrq73Fayg0jQFAWc
rfQHUUBSp6vVFNFuFgj57SKnyr/eP6LrRPj1UWV7nqelibueCJA9YhQ71M1p7JXmWbRJBGZarY9M
3QoGUXj9TDbtZK0ws5Pjhe8rOZCwkWKUyHTTz2PqQ3i/frOFlnW6y9DrOE92eg71XH+YlTE5GDR4
uv2oKBXCb3EBoMOqfohU3ZImXyHt/vsBIFVgiBDw4VyuDrJj1Z5IARkejRYP10KHIZ1oi/opAma8
x3t5eZp01/rQ6fkQNForDjXQ0n1iK9XGPX4djv/7ITj+0HyTvD1+zfVO5HXUK97iqliThwAP6JKh
VylQ6+3rtn8IYWe/1L0jjlBJzNP9MyD/6v933AkYsqNKxiLJvVK4bbUHC5bfoDsi/ZQ6tviShkv4
2FIqvCsVf12F6SNX3Ov08SYYZnG5qL25GCfXpGNA8e7udTsMD9qsN3svCbeaQNcR8f+ux+if9J8J
NbXe9YaGQLhKJzKNU+z0+odY6bjHGm36EYrJPS5LuJWIXYdE1mNWQEmDzhZjPdS9VrvoKkPnNXT3
TnExQL1RY1y6ENM4jrQydvdf2Kua5dUbQ1+Ue5NMgVcGt3/12ViCCx1rQv3UWF33svR9uNcU1/Xh
tmontUt+p3lUBRTo01ccFxdfWJH7pLpx+sUusHhSoM+cOIxAMozS3c9kXg+zjdG67iTxcxzlyqcF
2+1DPKIf3cBrPA3CzeFdS1dLBBQOhd3XH+8/02o4/bp/ID2JCEQjWZWvnkmz2pnudq+fahRaP3NR
J4gTOMvZSI2GvjewbdUshrM+NMouyhbnnBV2w/RXaQ6uMaOi4CLnev833RwhtlnCJpmlydphvc1q
FWnGwGDr5Bqp9QHJ54/d3M7npkBLtiyXf++vto4AHCDSBHm/kVmzCasIUNrLxMzWME7wgLwvqYdy
GmeAFrnaqqdqMTW/hq72I6mIj+9emYkXuSASeNQS64I8jUjVYLIYp4rv8yHSQOkkRhT6jlPNn1Uj
Vi5Ru+hBqLRbo6/bZ4ZlQScGciVBjznL9UdqWGFDA3oW54xyY691/XA0ErwDSzNzdp7blIcsyzEK
7o0tNejbd0uazeNK/W6L+mK120NlFQ2QuvS8eHhAV6VTHkrLiJ5Sl1QNNTBlY49X6zHDk4YNMoWh
oiAErtbLJhOZG1FBSTIqCPvHMVVIz3IKQtdDaXla0FelbT2c77/a22XpqEGZ43LnUEE/vN7gxomR
c7Yb7ZyHhoLtJBZhuLX/NutxOsaL2AKcXacTNFhYCVgOL9WCKUvNf70c7IpemGhZn/E/a/at5/SH
tByM70YRRz8txevO6eTae3Za9XPe9kaGvzpOr8sjUuf+55DOH66Xt3Gl6mfUIc4Zl/pDDzzS72Jl
PNVV8iHOO/WQxekPeJPG8f4uy+z6j3gs16Xyp/ECG9LhJlitKwo19lphauesDuPvLn6UOzMdxQti
a/ppMUjxmDfnG2nqm4vSpQXtJf2F1tFJj5Hgc71cP0+NZRyV3HbRgCBgmm0E7Z+abl932pa16Rsv
GK0bPhdKVegXN+pbgIztJTf1cwSe7YQfYugnmlafjAQhDJsKa+eFfXsOy9LaQwnS/72/0bfHmYa/
ZlAlQ0ZDG2t1SYyIzOrx4lhnVKenQ9Zb+U53xuTkRlbiL2r0PpNCeZ75kRAWqQHoU97g5udYN9Kx
Tu1z4k7uzi5d9zkCPQK/tEbpcuNaf+vhkE3iVselUNbk16cXwY1CWYbePqec4TNG0s2zPkq45miO
33I+nI28b0V1+O/p4BTC6iDy0nFffa11uUyIsMTOeaH37NeJsTxW45h/1suw8fVGM05NZBcnPTOx
lAOleZq5A/2E8vU05N3ymIT68KlNsHOnUChfjKrIXzoHcgrzqWgHCCkH/6KSEo2hGPONfFL+uOtv
jguZHg1mxUQbhLGvd4s27mCUYYJntDbmL1afWztDQwm4bvotoZ3bsELYlrYpKioLpOqrBtQyhFrR
OoN9rks3OXs6VBxExp2XsbXBPMDF3ZVZ7B7jGpnI++f9rYeEPccVRdUovXGvH9JuuSEjF+gQli3W
X4vHD/Bro0btp9C0L/fXeuP4mX+utfq2KmRi8TnvnLMjNDzKHfjxs9PbDzbkhV1jDs75/norUxqO
n+TEA0IDk8b3Rdfi+uHipertkJn/maup/6RUw0uh9eleb6Puy9h40e/aSy56X1nBgFyJjyYcYxnZ
P+lSpd7f/zE3Gw3SHfQ5eTu3JVoIq2/PGbCiVmFznydHsXdISlsPEESfIq81Pr93JZJcqVkLABwn
vLX2L5g301HIbknPEVZQkkU5jJWjB3Gq2+8MKMzwWAJSB5vLqGn9UL3bLWVdeFqg23V+Kbrob8Wt
fsfZlH/ScnU+vO/B5MSQFFbSH2mc3qg64CxUOyIzTNhOtrlrWi959ApsIrMh37IwW199LEWRwJUn
4WcMLFf37dDMDeY2HIxYbWe/mjtbnolll3ehdohm41eTm85GgbL+PF7XpBKStoVQ0dTVCbHmhOGo
2VpBhPL/UWeGt8fNtNjFdhMfuoWG2/3tXAcduZ7kUNEYAXpEsLz+OtoMc4GCqiQAyF7ve61iRDmB
WtzP42T/Myjo4KtT7i2wAgc+1fuLy7/8z+D63+KsDcqaK2DdTlTDwumHybJAb9bqD6Oq1H0fNvhx
3V/mrfdI64GiA1oh/6xCTplXVu+5oxVgEacc7Xn+aihwhhIHQWzUXMRTLZx649Z76z0Ct6Djg/7U
LWnHRnO36tLYDhLDFRdk64ePie2lhPC53On5qP66/4zryCK38o/11n0Is6h0O6WdFJRT+VVtxuER
fcT5f0PsuFtQkreWoszg4WQE49hcHxkaS1D8mhEGTU27KuvK/BkMQbWXNJCNKPbWLkKSB6EGTlJq
x1wvlahjEbqgEQI3HNLED23h7uo4S8kbkNXyB7soNtLdtx6Oux6aH90qKct2vWIuWtPI1MgOGGA2
JwKN8tTroRWkIGLfvRRKUnIE4xKkNari66Xm2eitpImcQIvz31lmzM9qgmlXFVbTxjbePhTjAZlX
MCGlXHodoP4xkuiH0W1Lp3cCBgnRBwj6BiYpo5SErLfMmm+/NZai/yRv3VfrluuHSvuknENhOIGh
9w92Jn2a3bEDGucCk3MQBDAie/l6/+zfnhJGPJAzIeBISMna6WfuF+wQ3SUMOtHovg2R9kFtNCk7
0JonYKPvE3ijjmfML6sSmqhSHHE9lsjDYZpaMoQH7lJ7PxeNeHHM1NhoC73q9VxHR5ahSYXoKIkZ
kL3rrTQ0kVmzOQk8Cr385GRZu2uXbPgUK/Psj0k+PFc10wMnCaNPtRknO1LUMdqhmx4fEv7lt+2g
n6EA9Ywx9cHZiKqvM9+b30ftwuhSQpjWAGZzmNAEyzQlSOxB+C1QhN8YTw2PTT9+y0okl5TMNo7Q
uY290VXAA/LCO1lW0e7nMNIfhnHqzsWUmmc9aQ0paPNSTwtY1DoTyPq7xo4xZfOXhU/iDvs+AneG
fJ+i2OJgW4n9O01G+wmZrvRQmeb4pJijExRTPp2HqvX2VgN8e0wcsXFfvvEpMeQHAi07Sny2q4+2
tPOWRL1XAjCq00MWIdM4J4X10FElbmzw20tJfD2TAaZgq6u5TJvWtMpZCSwu6GeY7whdAyZ6EEPR
bCx189XaEj7BvJKxAJB0b3XUMiTmUtRX4gdnaKN9nCh64EWt6jtRqwSGC4HQNFGuuv/Z3jwfi4KK
Yu7GgtLk6Pp8w0gkjBhT8oDmWXuKe6s9GW48nAoz2bqN31qKlqdUKWa+R0v7eilHgWkT2WHyoHQl
FjiTPT2N+tTtpjYvNkjpN8GIp/pzqdXt2GeDNVuTm6Cn5vZ+E2nFYY6MaM/+/xKCWeb9TVyBUAlG
cj1XIry4RsgXVwfSmyHqOjVKhENfWrtCKcu9SKPqoE8L5kJOIR5HC3SIVTjOcVaMHrqBsoBYRrhB
T7Tig4fKz5dZDBUKNBQmZZWJ96a0/EIH0z0EHThdvITrzQ+dotISA90Xwn/+Iemt75OuiR8Zax49
Myvfp5z4344wrQC2yXyVA2Zcr4e1jBgR4U+xdhmKY1IszXNS9KijFI7io5xQK/6oR/VuIXUr/Mls
k4uNB91GArhCJb3+DGhBwMEgyQA4XGNYdPf/UHdmy3EbW7p+FYfv4cY8dHTviANUFYtDcZJoSrpB
UBKFeczE+PTng+TeVkEUq+W7vnGETZMJIDNXrlzrHxq1LIWaXXjGjGSkoqLMO9bjbF7PepZg95S3
3pMt+kRS8SnmT0IPabB4sP6bX41ZC87xqwQ51W/ILaslCeQJhdnazS46FcDjHCGshWxAsbPY3SeG
WhfuWI0YLZBGQCbh9rkGXLSy6tMKA8CLOsv166jIHd8C8L6NNWc4jGFjBy4+DLexHauXYYTD2Ou7
4YXN95UGZgH4+2qufTz1I1KGlRya/KLU+nHnCjW+qFJVbOupmt5YdDZPjPfiJFMg4kgwQA78oBw1
DnM410WfX/T2aLDAswEYyywbf/DsOOefsRXMsA+iYM47PahGBHvYlKeMF1/67IDMlx4HKZC1TsnD
uvV6VBDzC2d0xjcj4LFdhF/bhZl3f/KT4dFQvDywJ5EENjDjXzPl+rbUySqBMXBh5r6zTMt3+aWc
m2gK6zm/MLs8pGgk3Gth18kFOIpTloA/zjBLmJs/lVJgvNRRjoeqeyQD+tErLpQmnvxqcAbKw57y
hEroWx1rvlM60T+UjxZwP+BvgI8kY7BFV9ELmhtoXc0TF2PluIGaIu8okC+GLBVXvlKWSLcU8A/V
zsu3vWF0Z4jiuHe0H61HpzdP9WR/WHCkHtQjWXKLQB8Y6tWnbkpp55MyjvvMyaXnN6BF9jmd9YCl
VqNKMhfXCd/hfKp78z29/uYsSZRPv7bLKIUudUrUKPgcMKX04zlw29SqhgqqWmd447WG5YBvOVV8
iQjIeDk6zany+Do7oTTO4UGFgMODa9k6UcBCmWSrtLQLzyytjQkqf2PobefjiKSjAqLnQRaV9on4
vSqMgFNZxCZBk5J9LXWg1UuaTSirycqUK3eqjAsg2vGtItUec4GOtqzsrf1YYQ9SlOWpAv2LIy8K
HAtDGY3BVbgex4jy0ARPT8ss9aKKPPcMb0Jx3leIVrd6bfpS1WIuNngGvj6xq3oM74wUFAU8qnhL
BF0Xu1OUTOKebs5BAJHaZL0W7tKh/cUe5TIKmwpIINdRrolrQXlLOEJ65VwcxlHr9rEqDT+SY3xo
hToHmTYr56+/1Sr5+zoe9QqD6+ECnF0ntwWgnyGypuKQu066sa022rejxIB81k+1e18YCh00aiKw
CMHkrYFGMN+Tvsjd4sAtl3mqq9Bx/GJAKdVrUvfUBXHJWr+7gC0vdjTaaomCwJ4VUeCWSSPEcIKk
hX3bDXZOG796QyJv3HJCN29rs/UOSJkZPh7S2on8cxWPvz0D4ZjrH3JW4PSOY8GAVUyWx05xqFqz
iDYFUlkBDFHjTWuYl6ZSIMT5+myuA/K3ERcgB7XZpZyxuqtMkld2Jr6xFc3TZWZNBxyuvC9lpzQX
Hc59YODIcuvUe5SeE6pBZFHpQIK35OHqU6xNbRWbvj0NV3TugyitcEQcv38XCyEwWy4P2WwpdH7b
3A76Rpgwv2HOjDJlNgrYVPrgFIES5jLyNcitB9DFYmvFJrLWBlXCqHbtP7sKeUsHWQJjExaTtj3x
4V5aLhp1JnYdm4Fi0PGjykGjba6o5aHvsc7MoPDiORDZgROa6lWikKlIQHIfGleYD6JKjW3k9m5/
Yvpe+l7LFRM9+KXkpa6uK/mSLbupXR5w6ppBRAxWT/Pcrs+sps/8MJWK7+jZL/aTv84SpxVkHxCI
XJVWqzRUCqd3C2YpygznGgzru3LUK0Au07ztAZUGlRk/V43qPsxtP5/Ypy8Fhe8HXx3ZQ9iM6FqI
8lDTyLuWSAdu4D3aF4lev399il/ajKRfOpsD4hpiKccz7NZKGFf1VB6mJiw/gE3Otk7WDdSAOKj9
gpvQ7vUBfzyqkB8AbkdPC3GRH7oVrZ3WHYWf8tAmTX3TxhishYndnQ2TvEUhPUFG1R3f9sz0iZj+
0jIC60JPT+VyRYfm+E1VY5iEmnrlQcHU5ixRm2RjDdBztcKJL1UHjf45AhXy+tu+OChYZAdJSHrZ
axIE2sv0QKaoOsRJN79Jbae+MiIcEJ22sHahGbV3SW2fUmVeY0e/rl3uF4tAI+Awzs3jV61yFRLe
WLN84tx8mnAA2HNyTVvRpOJeaNYX/Fzta1cojw3k+QOWIS1FZNs4xdt+6e1RFIGrQGK09OCOnyMc
tRQBmaY8FLmn7czJ7j6rsUdnesiTD6NnhVdT1w0n5nlFOiLz4xpPvADPSZEIDeTVRANKcLNposyv
twjH4+SuvGk6C0UBNx0fjElVZRA16vxUmLm1A3gUnzmJNzElVXUehlW9o9kbXzFxp+o8L3wOVLIp
/3LQcxNZJ+K1TWO1s4v4QC8HaafOnTaO1Rpbp4XlN2lueDZN+XD2iytwOWRIR9luIEV+aH6GSh0V
Gd4/B9HHERZb4Kp9tauwhyAZKK77oUO4xmrtE7Pww7syLGk3/wB5RM6/moQ6MhULKnp8yKWmfcnx
rj4HrpJd5OXwLlmCmjFOp3LR1ZjAEGBWUz1hsdFaQSTjeLnVo8iMIW/KmxpTmeSsDaGQ5T6o2sqq
Atp5jrxVQ9nlO0+Xk/1rJSsGX2q7aJuAe0J8ZO3zns5xQcHK6W6qZq4uucf9SYUr3TSj0HxUVcYT
h+IqbgOF5HJJEwjcx8Ih+0rk/O7+3NW9bVWmJaGJy7O2m+L3g5UhNI+1zh7sonH7+ipaXyIZD0A+
SMyFk0Om762Ow7ZyzNIzBvNexaktGHWuMEWK/oCNOByZ4jRuB7UtNpOlzbuiV/aRl5/yV1ydHH89
AuuK6/xyVq2WFEAC2PJGYt4LY063Xj/250rRqmAiJ2+Tjvpba3DtYKT0vHn95Zc//F3S/MPAq3c3
RGTIOKrNezfNqo1AeesO5Xn37eujrFfvty8MR4bdgnbkugYZ4TFhNrUw71MvU961PYRJhevmbnKd
aF81uXdZYJhw4tV+XEZMK7JLlCnQXgJqe7xlWk9kkRrN5v0sq2GHW529sSWwZhzYLL/wwlPAj/XR
9PVbfpUVR8aD7bruAOESkJT2bJv3TV93QanZTYD5Gir4RjVtoA9FOztt012OpsjbCkHdQI/V9q6B
oHmiDrdKsZYHIREgKJJWLq4Ny6R/t4Ey4U5alqTWfWxH5dbqmuRCF1DK56o6JRDzwkfGtwsmCywo
8ONrbS07yhsgYYN1P/bdbeP02oURWdaHvM+ASzljc4pb/MJKovtDLZWrK7DXNXih1IUXzm1n3U8y
j/Zl0XlfOAWUzYAuyDY0Jw8XQvMUi+KF3WmggAMdcrGYIwAef08884w00zv7Hvc+UKVeKs+9sUN2
u5LmYQ5hVmRVdW+qI4z91zfO+kK1TCUle3LJpbK0QO6Ohw4HnMe6UrPu6wn+bG439HFNJN1DYJO7
KVSHha/zqTKzjKITjkf0zLvdEBd94GDti1R1ghrshP9VKFN7G5e1uhdRewrLfjwrQEk4+8nGFhQ7
lz7uKsdPqaVZHFO+sT8v3Anvkvpnrl+Gido23iY0DDDAfSnT/s+iqyLr15wDvg7OsDCxgULBPFkj
2uLBoOCKldrnsXaSXYYlxAWfNN5ktnOKW+3xHn9Hy29D0bqAmorBowOM7vg9zZQkxjVG9/MEcu0s
d7R2N+j5tPfszlZ9WJXy0stU9cHFjsxPMVH9pYOYKimDg2Bb6m/ATWBOHY9v5drYUfFOn6sRDsne
Q+pRvRVN3NuPWRNrQ+grCBfMpxbhsr6/f23Kq3RBUbH+isNC0fp4WD1pykmajf48i0KBOefFdrZF
Fctuzp28rXuxAVOkdm8MyIjuLchQNb2eRBEL39RDUPDIW4RbGXKpPpGJHUcfnmgxWUYynAo4TT/E
qo4fjCQMFJ+dqM8AJ2HcsAu0XRqWst9YomjeuWXdKyeSk+PYSmkbXj3UUmAjCxT7B/ykqyAl2DtW
/IUKiMC2exwesEYcfa0o4s+vb/71rvo61JKaLP475LerMB5L1FWcZkq+QOJLjKvU64C/wXhy87ea
njq3Ux/jh8hec6wTM77+rqx0cPXwJqjZIQyyNpSj3I3xlTemkZ/1TneZuKVxNmExYPiJYyv7sq3K
U7LzP3xXkL5oL1EKwYeSOLuayj7EmqrwYjxsFYfOuxJJK6gjYnynVtHZ6x/2OJ4zhyjoLIGc8geN
QDbV8bJRiGGOIps28lPLDvdVWdDqz6vBn2otuRlmx7xBvy3zY2cu9q8P/cNrgrpdKnUs2kWGYz10
O/eUDhGpxPbcdKfryJvCbcE15kZv6Av+4lgLYt+D2wWhCnDOuhcuEqUD51KGvGYXph/QXqxtHwBZ
d1XMwhO/ujHQmaKAClfKJJ9m1Rx/1ExLqaPP2RDTQwZ5CPAoK3yR5p7nDxxZJ0b7YQq5ENHuwQKL
0ITc5Wo0dTajOdJzO/ZpWBfxRi9K67y14tCkI5Jb2QLvhafgWVN1MCbTfff6p13dGVhCfFgUEqgu
UT+ky7vamwO13NzojTD26YvoKsLGRjpt6qFw84tq9PAYa6soxUBcbd3PsYvhgJ9JT30npZC/5j/G
syyew4vPAE3HxZV59SwxqfPseIMT+51jJGednstLWdU9M+6UuCPNp3Qafvj49Bupb2EiB5WL8LDa
P3rfRSOlSugL5SDFPb3VboeWl+KbeR6ex1nV3UW2MWwsspET++eHmMj2AQPO5uW1qZguJ/R3qS0W
K07rFj1Dj0ZavJ+K+h4jaOOhKlX6yY4+nWdI35+IF1+Vib47ALnrg2wD/2gg5ItD7LrY04cJZ1Bl
qKw2EnrxRm0GMW7asZhKRMOE+daw47Haj/mov7dlkdwZhd6VT3au9VcCbcjBt6pserDUMtH80SEh
u0rS0nwHjM86aI4Yb9suhtGeRNagnAkomOMHguFwJVWYyIEkd2tvHSTSum83hf/4NP5n9FzdfnsH
8a//4t8/UepskyiWq3/91yH51Fai+iL/a/m1f/9vx7/0r5v+uZVd+/zb4akWv+268vOTTKpy/TtH
f4KR/nqSzZN8OvqXbSkTOd11z+g9PIsul1+H45mX//N/+8Pfnr/+lbdT/fzfv3+qulIufy3isX7/
60fnn//7d1bnf3z/1//60fVTwW/9v/m5/fiUpE/rX3l+EpLfVf+gMoDhASkXeT/Zxu+/Dc/LT0zz
D8qtJOQ03VEd4k7y+29l1cqYH2l/ULagbYhDD/IQXBx+/01U3fIjw/2Ddh/giAWPgboKBbz/ebSj
yfp78n4ru+K2Skop+MMs9r+X5UKwhj5OdMd+ieTnh3R0juFeTV2sbp0ZgxGlCRfjYQpf332Qv0b9
fpTVHeTrMAA6FoIh3DEizSr9wxpZ06B/adsMhPr55Jj11i7p3Nj6NDxOhvl50AfwUq1ebGtRTrd2
GtWoxmrZkz3m8mDPfZRuZJnY+97KFm8X2fv0sE8l58dR6etjcg7wHFQEOdbXV6WEbpzQs1LfWoYp
zvDcKoVfzF502cnxOYrz8JC4fb+RIMdOHEYrGvVfQwOSpkqz1KTX+VKZakMyuZm+xe03vx9yIR8l
hdBtYnTtDpE80FWVDJ+KMEr9nBYvepyxeDS7FJsHu91qeT+dyIxfWBowi0GiUqNkua2BmWlMFVHl
4ridWh0o5qio2Q65seLT62vjpWEw7MYag/W3rPnjcNwITRamkOO2iov2PAVsFFjWcKqv8uIo7Beq
gZz6CKUej1LZddmYbjNuk3z2AtyOlZ2rhh9ff5Xjk+XrHC7ClVR1WUJcdFbdorDJBtfLkgm6amgc
IG1NCNOV1b1ORRfB3hD1VOB5J1K05fsc7WAiCCcp1QW0DtnGy5t/d5zp2NtyWwn17ZAPH2pMC25n
V499WjnRB70qYYNPGV6KhVEHXl9Zf77+yj9812V0Igh48aUJufZxnmclHkXj6VsbCp+Fz+2tHfbd
/euDfKtNH70k19Ul60VMaknZ1FX8iGptYDeKdNtUyrQZrHg4pHYEJHQ28nkxtUzfh96UbU29bA/t
YERns16YxJg53+SdePbApn6o1SnLgkaNcBtaKk4fok6z9nloDZdxNuQXnZukXP6zHqkX3sgJ57Hx
M3dCukqjPuCHc2e/D5t+QE06UwU2rcLiwE37ZNtbNhUVjMF72+8jtXvo2inZttLQL0Vr5Xej0QxB
Grf2e0zG57M09ZwA6a30i9OYylvQP9Ou74Z+MzHNU5ARlLdpY/fAzZzykLepHRiwG3YWimS+0eTP
UyTqZ8gOB2Qew4suRUmBCnNYbbkZhNfFWInMBwjsXKpD7l0YDWmEL3tj/jwDYLuAk1FfxOGQPgj2
f+OjeDYJrkp24mOjMhZ41tfa+85OB47Z8rF3KDRWsCT5f0jMr9JikfS3ZUeyGPU7bM0EvryRHu4i
IeqNO5dy5+VT/wisYwL7XHgbZc7NaxVGVLvJRT8/RdpEqtcKsTCe4YcEtZnMYAq66h5gcf9OGDml
qiapsR1xLGuT2OPetbvIL6o8ww2vbs51kRp7LK3Tc8dUsrO2soArAHdOAzsZ38VV229tozXPrHqM
9jVB3OeU1s5bpYJClNqwwAa3P+/Mrj7jlHaojqkfyDvnW2586IwY3qayFXmLbBg+hIO0t1Kt+j1l
MnWjD4Mf9uGbqVPuo05O542q7jIwFH6DT/CciPKqQ9DN7NM4CNVC9e2wNvet0usBncfuSo5mEsT0
57dZbu3llKGxlyrhVmkq8cHp5N6wsd6rO1ZQHdJl7q5irkxBNySPOPlsRKZedon+sSs06UemdZtk
4j6105kWbVKf407m3dqkuOeVYurnZZVfxlV2rZWpteUK0O+BwHyAD1ul1Sdp5FdoFv1ZRrKlDCAv
QrV8Z9EgOncjvlhuo6egFVa/0SNv8IcYTUmLnDrxMyi7ftRa3TZpl5b/KMatpje+Ndd+JccUJQj9
TUV1YK+gAbL3Og/3epPCoo3xXDhJnJSt0Dch5iHbadyobnqdzIO+aVWzgEdWpjgVLZaPepuKazPU
dF9o3rlwE2PTlfp8L5RRP4+bPrwN2+wj2gTg3aeuP+hx3G/LLBrRTO8UH3GkfNOXSKIUxXRAqjP3
0whuo1WLfo9Z6OXUDPvGHN8LVa0QPyjfwXyM/Gq0btK5vFPgCTx4VdXf6ogRvu+7Zj5P1fwG0KB3
WxbWFCQoVKPh0qLB0vafLZDQE/7fvm7Vt3Y0npVZ8jns5tBHRbDdxGEtNr1itYGco4dKN68qa8wv
w4yP5mkf+qTuwWpMT3mGgYVSuh9nt95rQut7n2zFc3090eUbOQ6qj55tu+2RqNwopll8Ao11lhvO
ZdTUaoCNJDLzc/2oJONn5GXASg/xvMlzZW8OznwtRuWTEhthkJcekFojNaabiaQP7MhkBKyq1J9U
lpaUobIbbfER30J2nh2fAYn8gFnZTVW1j24SNwcbzCQSBoINugTByTrXLdglCNikkM5R92uw0sy0
0PZrW9ma43Snzfm51szWrlKAGfYoT7Cd8ttRrdxATw2LeFAHbuwRwIVzJlp5MTTpxzSdLjqnMy6s
CG6SX0xPfaPA5jeRD6iZYvzEHtsYkf1MTO87z7nuuqLcNoOXbNTWCremUZoYkKiC54BXm6jxQynS
d2ACT11sOejXB/JXeVjS3YUvTEtjdVblMECzJnHqraco80SvBhPInW4ly6awQg/JPmPMkQaMrba5
jrostPdI2tkdPng9lNQ6K5p501d6E+5GKeN7t0xKNIlae56CvKiqj4PovKcQKR1MVIRabodeDm87
8KNfIhNF50BTFIUafd7QymhEN32YEi/+iGuAGgUCXXQSrBJjuV3UWYsuoiyeQNsjXDaWtvWpRHb1
NkElOfKHQtFwCHDc4ouTK9lTZ9Y2RafKlQycznWzUdW0QjU+ciAT9clYfGT56TdSUdtbLA9qojdd
dWuH+ERyW1VdBdM3QsK9D1XMsLUC2NBFIvrBCqY5roXvutBHNkoXZteRObr3ai1nNCKE3tfnIxXS
pxhRe9+A3D4/DV0+RhxAVjLfxSpeOFu1aaG7VsBN3I1nDo0DDX5oFzRDNmBCWSx8DUhz1aewcBqI
Er2i0/Rpcej2zVAWN66ZQuvIq8J6oPSbtz5S3Fhfm6HB6WL1go+poCbhR7nuXSlZLChQ6ePY+rCl
kKcXoYrmQyPpsvrAtPp7A+sQ7KXz1gS8rjsIfXMHw8OwUOOw2AB9KQ6JniISrNgtBoAS5o68QGkc
B9zWGFCNLtQkTXd1XRqlP5Rp9gjHXYdM1PVetoF3swAkdDrrfhgVerqjyYOrpueA5d6hLxXuUQWz
tAA+lwPvqDNHO8jSxptAN3c5V6/GTj+r0aR7NOAjYpbthNFnyyn7GOekqLGCoZ8qeF+KlTxTECPe
A8svN3o95rXv5nlJthDD1z7TsYoZt6061AXneG9OvkyjAvuDwu4/dBOcvsukgKSw7XTOjmt7Vors
CmiHGwKhMkuhXeRuX5ZJUKpjGwL8Tqts04txQks60pPztNf7+U/P7RF69riiPiqiSowgjCmPbumY
mhep3ZjtZsw1Ywy6FHBhAC7XNLayGLuHtlSJ0ZUTjm+GHpDFJuZ4qP3GGpBad1gMdw1d1ByST1SA
6MxiKYPayjIjmCehbet21iO+YqSOAWX9lghPc0rzp8KNapZY1r6xq0S+Q4xJubO1eXzHn4y6ADXq
7BP6R+1TM+Xjkz411i3rvm2CXkmsbj/pzlht1CjtbyajKXW/m4tFQL7D/JEoZTrvo4Yat4/AfZv5
/eBACSSSJmqQ4n6TMhm2vEy6YWS6MjF8EolFtFPCTnJWGvGAHaWltVh8K711n0ROa/u5UpFRJT3F
6x0x3bE3Vh2lj4riQjLANL5LuGTOPaZRQ/qkiF6Em9HWOdNMbUwmNpJQ/kQ6hg9BlXvst7nW9K5f
FTGWcEpUwY7QLJndOBrEjDFSdKS/yLWvysypDQ64IayCZpDx7BeuJ6SvgPU6tJ46Wbsa2dvFYF64
HwajRKeFDSMaX+IHfFNF2dD6gJAy60zIAsr34nifY/BpeO9m1UnzS80GeXyRxp3JkT/bMW4obpXq
ftap4zmZivtkme34AEdLxy5FQxCdgxv9xx2xwvqzmFK13/Ww2rOzCWEHolgnC1+XdOL9UkzO5xzB
qe2otOjKog2tXA+TGj7OXq7bFx6rI9lqTNjAqa9C1BnN1Jv9eYw6bg8JCpGbiXU47Eut9RDXmdtB
bgEXTTfjoAuB80kW3jWOBPYGGh74al+yZ3zE6OYimNq8VXcKGgkzreIEEYgRER+/rrlHbqQGvhI3
i8R8Y+B+FW8nxxC386DNyQ3Ogqj7ZPQmrntrNN0A9E2i+jCHVNVXSxJS38iSEqonpY63npWYb3Ns
NpIAYIWLWa87ZjXt4Ga4sZup/egNUYIgZmQ3ua/irHHHtSN9hwdUjeRhbxk3phkiB6jNWvTRZolg
YJ1ym2jctEFZCKgwfTxPtGXgzNHIZUEryzzQ9Lb906kcJ2IzLpIM2ARl7WWjDmrqq3k8fAR7qRR+
3CqmtXFqXWw8u4zQK1JG776sZgOfXhv3M3+m0Hs15HVz53pK/Kk2lfpNP3GTCUK3FE+hqajnReaa
GTEVLk0wllYvg5Y3e4+t1qwHjkwbTEVEXj9MeiLjba/leUJtmseA+TE4HmlSZ1lnmpDhJ70ZzWdQ
67R7DEPpb6VbKc942nY5V0B6fhvaXsOZW0Ucn2VtWB/UIqrktsG68LEg/NMWUpu+2rbtItRZuuFc
XRVaa3+Yu6i+7waZtH6OADgXh8ltTN/GFg0qiuPNg49MD+eTUyYWkn4aqWQ+hcSxwYBFewa3OXvI
uUUMmzjBpv3coVp2QxU1vWvVuOEwsCq7DbDdFVlQZ50W+73WkV1EIGDn88zs8ycjEuMuGtSEHRC5
nE5oawx+4STxg4Q6TK5lZ7ncEkOqnD1iaMU5rLfe3mSAUuogm12ZB3NNPcmn1DJvmyke3uqJEjk+
DJfqfiCOsbCWyw2Ny7d6OAz30u4MJFPdorgdpDeQdHC6onROi034g809apMkef4x7hF9Cyqaw92m
Fa34MxO2e2OkqWkErQMO2HfLuE/8xBsWghjKOHd6mznCz8ZRmr5nVTQHc3xqCKVjPH2se/RAeLc5
e5S95HIzOpJjXVF6kyZi3+fNGS4iTfzWLnKT9D+N32PjauOUlCr9ZeF0uXU5qG5znVG9uG/Hkgac
rofQVIF1dHGQd2YeAvhyrDqQY141QeSF7huOC7MNMjcSRqAsLi+7xB7kyLgdFsc4ZoVY/9bp0zgO
IsdAKBfuIzelRGxCd5znBxEaenluJSK6cAYtfI8gNMZkyNBFY4BDaThtKV/KN3VqoWDWdam0H123
M3FZz+YSJV437ScfoWoMMFKaIWInNT2EFw4y+RKY3nAH9TpzAV5a3PHDQspqozeyZ0mTyZ0Zvdco
2wQD5feG0yfebgLT4B3qQcwKglKgbvxCgTfCrdfRDwJsqbWJ5hj6fAF/MN8Z/IcztMhMA93WsXnT
pkB+/SYZ4mdU7zgIByTRPb+K49kiS2kBQoVK20VbT5j5c5w16ezrWRPZPopO6UUcFbK+MTEq7vys
BLqxeb34tPJ5oaq3QOccaEsqcm0oLS5Vv+8LbDYNIz2K5BbyePlWNyPcihJ8KCbfgdu7qxpTe1tb
hXaFx1MdaLVst11Rd02glz3bJfeEe96AxztHbRmJREsvs8HnS6D3nCqj9jlN3PHbM//VCTkq8/+7
2fIPezL1c/lGts/PkqbM/4FOzKL5/PNWzGF6Koun9vvWzfIL3xoxiI79QU6jY2ABFQ3DPar/3xox
ns4PLAQhmF1LXYyT/92I0d0/Fv+DRTjvr/bNvxsx3h9UXIG1gBwibV3ktP95I4b9ANfHwZFvVZie
53Jsjaar962NXWfoSu/KlG5ziuRz3Nn4+8+vqsNlWnP9UbN67xDpzsN0vKLbku2nYdBQGhdO7AAJ
dcbSb8pfw3P/PeTq/hvreHbUwqn3lo4mSkDwku9Gti35p101xr5rCAC36DtSKPhusl9oMx0Xo/8e
UV/t0JECqg2ueB8rXmjCF9bqyzjvypMopqWA/3cZ+u8BVoX9RqIqY6IzhEZj13fneq1HiOO1bvSY
R7o9XLZtYn60Kv2Ga1JzRT7p3tZKr3zCI0pRT/TSlgXx0jOs4ApKblLpMbtmb5sjpweAiAi5/SHv
HqhtnKImvDwIQObjLwlXEQES6VR7IzL6N+Xgal/SvHHNwI4W4ap/Ml0/0AfHOsVV2o7rfZOUlknq
0lXI5k5gXf/Z318FbIniOz4IFV+KzXVdQVa8s+ZSP8HT+9knWso/3x0HJOGkClSR9y6T/pBNxVyc
pSV8Z+6CM5rD/+wdVmFBjbwYOGlY7Sn+VVtFk9XO1nL7xFp6ecNYa+gJxeYS+ci03leEnru+b+th
g6uf1W5ff/qvWKQfFysp7/FHws96NCelqvdw9sbhJkqsSaW3Z7vdxrJ7C82puqNSGVFSv8/0JkvO
NWiW9QXpV91cWYUwk+0AX7iFyubZCrdyG985B8PCkyS+l/c02NjjR5wSGNcQaut9OGPvEsD5EPE2
MyOz2MVqmqrvE5nNz1rd4wnTK318QQPfqzalUxfyTDSl0//DyVgFF8uMh97NomYvlKFI/c5snHsY
dN7H1+fiZ3O9ihtdPtcI+6TNPqqi8t5Qs8j1p9Y8CeP+yd93VyGDjsOcaZVX73O8E3Ifyc3iwSli
95cajf8TelHAOp4mOdgdMJ242Rd4QD9g75p+GiakNv7Rx3FXoaLTojaH3NbsFW8S0ItVCs706Rzn
n23jNdo2n1vHK1E437uqpJvhaVHzqKf6LE+Eup8Eo7USDAfsHMYhh8LUSqq9iDfABMBj28WbM4yU
L69/pSW0vbCb15QxsE3mghCt99HQjNedmojnQek09xLF4j6/HkWHwe7rQy0f/qWhVoGj8zAODaVa
7k1nGMcA5aFMvnG0cXQOXoLXDXKGcahEVEubeDgRrX62gleRoOcyrhmIxO293E69nSPRFIHdEcXp
iZf62fdb7XCjHbndGUO1j7K6BOg76UaFeqjiFPWmyLVkanzNlqeMiX72OqsN37tKrYeUW/edqN1y
S8/JDLdzF5cPr0/RT/6+s9rwQOTR1qp0MtYMP5ZNWovqs5nT3D3xtX7291c7XklHXGlo/e4Tz0so
5CGdydlwCjaxgl/+O6CsSdvVKHRoUWm192oH97QBLPSnONIwv1Yp6uvvqYYiyx078UDxr4ihOOdW
ONCurqXqnAj5P9m2a6pjqUc9Jk9MEeK5HvViQ/88qFQMEUJ1lbt/Nk3L2N/lKbaiOFyeJ9Lwthqi
IJ0H82JAPeFETDiGn/z9GZfZ++7Pl9BzVMcoGpqmUyYCsxOmt41yRQAnr5I89g0Bg9kPQ5feYZdN
2XsntI1Pr7/bTzbUGk5GLSGbGpP0QqUzXGxqSPfo8uqxVG6SWhmUN4ggQ6d5fbCfrcdVeKgVPUJx
K+cKJdDNTDKb1iiOTXN4Iob/7O+vogMFTCVpRtnsJTo0G6OgJVvLk4YCPwmoP8hvenXc0cap97H9
/zk7syY5dWUL/yIiACGGV6hqqtvted4vCtt7m0kgEAKEfv1dte+9J7rkrq44erQfaEpoSGWu/FY0
eAcYUoJbuIB497BMY7wVaBlMfq+attzt59h6rp32MAqWoJ+B8dugQDd9lgvKYy9/iysf/g+CI2ft
PE3nuHJbxXJXwxTmI8nWvi6NZ/QrT7TJ4eW/dGV+26DUECVq0cBK9gSPun74HMDi52NI+5rmHK4B
39ZhTD8rD3Ynd5Bwsr5I/RQVo5f/9pUZEZ9//ZO11adNKEiA8HzAdfY+bpa0LfyV9P9dw8R/1q7t
9pCNqk1mH1eYEe58qC11YImhzwuVwtzMGoISt59x/nlPfgZQr2MIsPN4IiuK+9kcDwXBpHMcJHL5
dAFMy5idl6UmjH2ED3Pw0VvMdO/27taiZ7FqOj/FHXWs5PZA1fbRm5tbrJNr39da8TX6AycUl/Fw
vbdACkb+HaDJwZ3bq9vn/yRgelVJDPtMyKsknbKCCO4YMVPr9K+9cMp6D3Oz6erpR1vV+4IaQjy7
jbvdw5OidoHCsh5Pbb+Lt9B07UeoC29GYldG3hb4ovQcjKHp8fb79hsdmUHRQZ/kFkdSa9nuQ8ez
RAy4CclelBwCxcL4qnO7StjEldZHxW2IM7QItM3DsBpgb8bYLaSz28QUqgVMozp8qpMIBnYZhBoq
prcal64NurVSF71yFgaLOHmaVneKzPH9CtHOT6fpbtM8lPBW3vgYl8FDt+DmqSFvRH/LZ+Dau1tL
NcnWRpIRoXvGEvLe+MEr1EDlDW71tYdbK3WIq3XVSJOcqt1MdTEvEinRAaLrLncam8harKj88znY
KbJIqTyG2zIUMcJ3tw3YtiiayJiCZhuKk5LTu0iOxxYFWrf3PgczT06OeoB5dhZvuJFB+c/P0Ccf
MoI+ltvJ7Q9YSzWlgB5ukxSnTsH85jAyr0X38zLrr27Pt4JvqkF6kIMQp1mNOzZiMX9Ydr++Qca9
Mm9sx7Eg0csqOCalmJqZv97iHj1r8RyMtwKEa3/AWrF7vWSG1FBEhl0w7YWClAwiKailY7et0mYB
UplUJjhvCT0ZyAn10OCRtuktuMu117cWLbo2GvRqoB4A0G90SCbRHikUTY7vbq1aRccOvEakKDA5
248soo/BQPkN5u6VV7eNyMdRJ/4GfdMprPetNK3iv+Ix7eobG8Lz5SBqM2BEBMAQh5T+REIWYuFK
meN28G2IasQ42Xsz7XD6mhS9sQzO0/2ZbA6x1jHwlaRe2YhzpRnbpNhBPILeQafbZ29SbC6dFhux
FrPx1m5tK4yZ9mD25AOuc38mDbhtFXbniJqj2u87TCYs6ARqPAGhpmKdW7Bm01d9CfRDNmATBa5O
lnoR8iFJtWOwZvO1Qk/QhYDge9qjJniMYVb6jmH0byFdr01WK0gOoZoJyJ7x0zwTaCIC3xx1Msy3
huba461lPIIiNJNuHk7BjqbYA/45ffOiWC3HdfKnKU9GvS6gyLJEvGl7wMKGYP4ArlL3MDJePQ5B
BQKfQGNBd9gjNFbkRnkAJM8CCPgcSPv2nw4SkfcqlKx9jSw5Ek1LOrC6MEOXDnm9dBSHsmRR89cE
9E8DBVegu8/dZvjnVvMJvSQzSdHwEBlUMdA8fWrrkXp3ySoa/zVsPtah1BVsXspYK7Sbem3U0V8Z
zBzI/Zyo+PcKJlP6HljxCuCBWCbQ1TUk/VLXIYRrN1a8RXn8z2UvtI6iAbgcs0F3cZp2ItoczXkx
vwNkUUBAZBIoXCpo0WjhK7gcPoZLJFnZgg9bHYTxNn0Ktz2Aogb160HeCBzO0cdzu4K1gY6zJl3Y
9wPuVkZ9UkPYvEGi6gfbJERuhqxt3gJVlebROGVv4F4T39JoX5lQf/qD1M3QNJU4xW3vA2eyHUM+
3Or0Pe82z/wqGyRBhw0NWF0jTmZWMPpKqnA/IGDv43wT/H6RZvvktN3964L9JDia4cwWV6QbTjwN
+89BMNavTOaltzLw1wbJ2k31jC5WE439SdHIoAshiQ4+z4jb/e7fNuknL89B4EUbTMRPNdwuvMKo
GYWoZElvgRuvvb0VuShhGmi3do4ml7QrQQlTharVrePz2tOtDW9n67Yle9idWi7RClb52dspkMkN
vOW1p1v7HVSKjdrmjp9Gf63uoNGSJR2y+NZ2emV+Wqtu2YwXTwE8HrsqGRawOKbwb8AXiXfj+VfO
ertdFC5impPQzKdIdz509ONZGxw1XZqhttrzL06T33YQC2izdRE6AU8ddPqvuD/uH1PemBtPj58f
I1vqBRykBiqwVqeRgj6AvIZE6w7vyFlJjKakQoyt/L/++Yv2+ae90Ve+9r9tJE9WwgAzFEjzuFf6
6dI9trP3d5OZzu2GYDNCTIC+4FpoBgN2DspQLOT9Kutb6Nlrn/r8k568ekehOQZsRZ58Hw0beQbh
IT2CT5FFRd+DEXnjnLCoaP85uv7tmX7yd9Q4JjxrRnmaWbOv91217GHp87D7vnWkHl/RaJ6bh2wd
W/zGMOuGQ0TgevKgKQ2GN0utpbnxKs9/LAgCL3/xGAMThtqMOFFdT/qQZL74ihPc++8s3f//lwLM
efl8GgGK42fecEo1/7qu+D0i3m4Jsp5/ecA/Lx/uIUrzm3iuT9U0RZ+CSRyAVHFdkPamhU4M3FQm
PHxI9WlPCcTw4Ec6jTt68y9fnc74nIkk1akzWJwFQIPqO++m5BYT9srQ2PDkVC0AlKBPqkyl7x+h
kJ+KpI/EwWmz8q2vCorV3k8qykogfKNvmw6yUqeeuXG5urJZ+dblSvcsPHe+IlxDo+pjpbtJ52h6
UN1hE2KCIXcAvanjLzm/w5OVmKEXuUsBPSonMBgOGvAUICzJevfyOJ3f+JnQydZABgRFcDXCO1f7
DM1GydpN40MgxmErQdce1RH5vW14SHwv+PLyX7w2duf58OT3zH11boVaWdl4UMUPM5AMORmbKYKi
LkjRO41evOr48t+6NseskGTVac1hc+zBTbc1aV5nm+RFT3yQT93+gLW+a6mZrzvPK9HplBKo5hWa
nNBw1d+CGF77BdYah14llCMalMs1Zs23rR/29770M8fxsdb4RKFe13sPaM0kcDtb9wCdAOGtev/z
7x7Zjphm1c0WRvtw8vx9eUv3Lbub++yWddu1p1vrAq2aXdwxXFFpQNm9RCz+WoHo6zQyAGRfztKs
4j31WR+WAYSSGheWZoBvGJkiJynjH8hYMkEMjW27P21my2g+Jmz7iYjHCBjFQcJ3cJmesBO8/BUp
30HWlBU/sb1tTgnsK+591jDH32BN/qHyMg+yhu7UR9DlR76nHvnmh5+qysy/3X6ANf1Hk9RkxaaE
7ulmfFBJPNz1UlU/3J5uTX8WooEEpMb2tA1IZ9wBdIhObIToVei0PYCLfDn+vVzoNGr8AX9Oli+g
nIkPqwnoLZzalSVgC/TaBuj03mPodY/E/ibUu56PAzR17Z3T+NgSPRGyfYmB/jgZSFh4ke6DeZXC
+TC+MTznxfTn4QNC9uXwrNqMccxZc56ew93iR2gF9bYdvf1CxPGNj3ztj1grOZFVAlAJwzcIRI1a
eLT0rAj5RJuCVEjJuC01W6gH5egMxJNuT2QZI3T9T2ERzoFbBRIk78uR6uKIV0LL9jSkaJPMKevH
jxyYkm9uH9payeGa6W4b8Hgtwx9TjYRGNUVOlTa4T1++Oj8DPMKkxyKb6/EdUDztaZ+aWyvs2te1
lvCmTWRmiQRhVU+JKYJhX3QxdNnyKWsDdEw6jY+tu2uryEzj6DWn2K8VOg0BdqhgT0hSt6obLC8u
B8nT4P+1NK1PrVrm4wRszrbqW6jdK9uELbsbExAMd6j+TwEwIyWZmMx1srsluv/0DujWDSIg0pyW
NYYIGVwG+mqo0dPpOPb2+vVpyKVHazRfeJ/2PoOVFPxxnXJi6AO6HHcNQbAO0GB7CkXgnYIB1x2U
D8mnl6fNFcEjuBSXj6+8JKhiXtWnxEywVIMxTi2KpMMNFmYHWVoAvRj9BOi8bz5pr/V+wP/SB6Rh
T5GjPr38Dtc+vrW04fG+jSs8o06mW6YfdFPdm6Fqk89uT7cWd0AkoHCo/p/4Bt5NMk/zIdrR0uT2
dGtxx2BIaYoMxwl9itkrcMppCdLUTcHzlaGx5XKCe0A+cHxyD23jr2iFajRoXrcsPK893VrS8Iek
1TSK6hRk7Ded9zVHzqQ+Oo2MLZEbUdWIVI2r/7Qgle4zXP31Vt9aclc21T9EcMuuGhCbWMkGFNLz
OOvZm3ryIrQYiGUmbl/XlsLJKAJcRM6YmRt4ImULQMdcLDufbxz81z7A+f+fXDTRdRi3pDJemVTU
Q3kpKCK53bLzu/Zwa2WjWQZ5I9h0lWiXRqNdD3hAuzO3VWV7Ek4rttI2xcPROFgDRTt2r8QeUce5
Y61ZycdtDVovK+tmah6JNv49gD5u+gWA9i5HvUfVzYgxzUpwHOK7hO7xHVPw33Ca97YEruljyoka
qhNR4ncquCjguuOYabQFcADCoBXFmzHsgDM9in5Lcy2G5kap/MqisvVvZJLBsDCDfNeYoKEqCmWl
DmLlqhzZLjbHAbJCahTZzIbWA9zoYa96WtcNBKp5W9xiOVsIBzrMRLJWZPBpb9sjU3BM2vpwuFGE
uTZC1oINUq2MYgzbDpwHhoKurdIFRJSAAtZDsLll/yPby7gyIdBIaAkqY9DJCq7rEqAtx03NlsQl
C6x+qqk5H1kwEQjUxgEzTN0E3jAtvVxczdCCvTWitiDjYPsmEzQXm5qod26Ly1q6iUE/RtMSVm7j
FuXoJP467yoonB5u6+HESPUgDR6uvToEiJl9iVrvp9uzraOWLTBqhq3PmTXIuntCqvrRE1BIuB1U
tkVFtgtlkiFkZeQPv/x9uucjqvlur26tV5XKLiZNk5XZ1naPwLQAreY3AbTJbs8/r7Unh+BEqhWy
/d0rp07TL6yJMiDuulsX+CunoK2GG6IIPgN1DGIc5PqPHJmyU72EjmdsZJ2xfbpvu9Y4BjcgpgCR
AWFo1+F8Y7c5j/AzyQdbBwfaRbQFzchKonty2KEMwaYczAAidf124HV3y3js2iBZizbs6gGSC3k+
VtBsy5ru9Waa5s7t+1prttEY7pBhv4d9sC5Vl3zol5u30itDZCviwjFtvRbCbUweX31PFXyJjuG6
E1VEI3o0Humka7dWHLCqLydqy0G+hOMbK/kUVAVMttZDAv2L2z3PVsPF2brDahnDNCUy1DkiiOHX
BF87J+lgZMvgKMBQ2Q6zvHJoiX8f07b5haRE5XaFs2Vw+4D9LVI99h8af2ilLwq2ascUsa2COxN/
u6xHKStMm+nYLEFz4HTZ3aanrYIjsNTibQRyzap2cmjnLDkQrohTqR06sss5I+BGCvME5SH/Saa3
LF5ZDqvEyi29bVtXA00kx3RC8QhkLbbm6TZwmk8mGNC5lbCkdZya1gqu0HBfJwCql8EasoLU1Xav
Qbm+MTOfr+9hGl4O0bRNIjNo2y0b1Zgel8Q+hL0EeHvzAcYbETwgZu75xdB3XXtj3K7sd7YaS2Ue
BS4eTgh1uKp3WbZuJ2i9tg8vb3jXftD5/58caEQ1xERo7S69Jm1/C7PTT+McB+99BHN+AXbY+MXn
XH97+a9ZZNH/qANs88QpZdhgDc5+4U9x/YHVRLADREIDezf6U/8uiHsko+BWR4NHoDahFlabCbO7
VBDzles+a4qqNzw77t0AMGW1NJE6wPik8Q/QUYDu9fJ7Xhtz65iX844UXxV5Za+q6C+pOigk/USJ
L26PP//ZJ4OeBeCpBTBGKTO/IjnM27ITLOXc2mUj218wGjkCcnjU4+XX3xn8sbYJBDy3N7e2CALe
Vg9qBC67vu5P/iar+7Dijgkq288O8M0UFozQMABY9jbm3nvWDI45Z9utbAb3aNuTNSv5FvyqePyZ
sum306DYerGtUWlP0g4RCVugkVz5fq+n0a3oDkvMy8mC9tBGK4EXT4P5FzCrn2B/ciNmuzLNbZHY
DtD32qHFvpyUaB5IBwO9cCC+2+3WloXBGCyNAeHGOduI6CtJvOwdEjDxjfv/tXe3lihTu9pEQrPy
X+B3H4BeW0vj1tf4h4e03pWkqIZn5RjLf9Q4/7WvleOwWGE4Njw+w3kwLQNcsr4OwRCfQjj2uR1/
tkIqrWuG6H70ykClzeemZvPXqWGJW4Twr7ztycbVshnFrDBDVJnG6jXydaI0MSdHt3VkHd1ZUg2Q
HrO09OVAPxolxVsAQEa3CWMLpGAoOWwDSK6lVAJAQw/A8Ndq9AfHspAtkQIocOn6FbtAFcd7KfWo
38Q8EjfG5t996pn7la2RalZURLeKQ3elVf8rgRaBvzaLIH/V3j6PZVvt70J/PEIH0f9ga7bexdw0
wzEE6N4rdAakQIkun18NuEDyGEdLB6ARTtg76PSHvujxP+pgjKSfmnlOoxtvfWWRnml0Tw+6lmu6
jLpPy51Q5HWFl0kwT2c9uIXyttxKa2/puybBUddEyx1q0TSfxda5rVTfOqY5map2M2taVhtYnXAR
eMOW2jH3ZPuAAOGKO98esDLZz+TZERKnHpYDbhcF3zqnuzUwLG2RSVA7aMRVwNjRb6gblgw+xpef
dVVJG8BLATbmWo9v4rFOP9bE7B+ctgHf3gbaYEjYuODdgz2EC1ic5PPsuYkw4NV6+e5JWhEgvLH9
JuAq/vCbSt2FY80+urw7bKIun75EYvNi+AOXYFN9YeG0oVNnv2Vx9/xqgoHM5cPHFY4dfYBIAOTj
HgYd8ceNRW7KOKgCLx8+x57w0h2RnYe2gLsExJ3X2iz0s9u40Munk7UOQ79FZAfTqK7s0V2UjyO7
pbs7P+XPvfEP/0Ft4EQRjQs0kGxVXwmYdj9Cs3ivJulNbg0T8C27/AVeI0w8b1laai75/UiHGZYX
gOG6jY+9Xnu2D2Kgadks8V9RwL8nvVuTJ8msxbqBZA4m+YjA18Sw1eCK37Ox853iDQBHL4clRWPB
FHcI8sZ+8+6MDgG1hnMgcevhIbbka2spUQm8UMsBHW8Hz/cf0S5xS256RVBAbMXXwqExioMOsbUv
+THbUo0FSzUbcvgkxVvJiRcthfTqbrlPBIwCjhRWaxsQoyPu+k6f3laFAbmCO7Hc0nLzMv+Ios2Q
w3HJrYCCLuHL7+MtsQyYZ9IS2Rf5Y1O7Oflm3Z0uEMSGtvUaNP0kxbSNPH4fZyM5TPHmVvoktgRs
h6tFH3XI5YuazGhsDz8tfGndFpytAPPqeM1Cifxo1Gewc4CBwUnHI7tBxbqyU9se6UbEJpBsRow/
VRrF1T481nHzxW3CWAsa/Q9okw9VUq5bD/j53je8hZKgn6XjjLTWdAW3jH6NlrQUCh4s0Jn1H+q+
U5+cXt8Wf40e2khNOKUlTWV9gsSlLpedSKcbCkzyLuc7MnEAx8M6r9xq0dy1zcqP2wx6vtu7Wyew
YRKGNTG+K5WyK+N5RBMP2iFvJBevzBqbpTYPZ6R9WmHck/SdzmBzN8S+G9KFJNYJDGNCHMF8SsqJ
ze1XyLvJ+20ZR6dAHIzxy2GXBGiCsY1j6LtN8z5JBfueEaGcrm5/eG6G/gJHFr/G6Qi3DQGIhl6/
xz2sfdwmfGKdvv5McLlCGaJMNw06e4M7aFUALFp9cJs21oqFMXKQRBUyckO60O88CuSnUZvqvdvT
reWqKjVFKmxwTcGp9DFMePquXkfjtlz/UHUlUdaksAIuWSimvN3mOa/W0S3PQmwKWswMqvK6TkoB
DvUx63fvsR+ZfOc0Mrasa2IZ6do6Ssqzov4wVR45GK8L3Oa8LetaB2y/8/l8gvHIAZ5i7dk1ZXeb
kraaKyK75nA0gHigVzALhMFEfd/LWXiOz7cW7Aq3LuOP58O1Hb/AhPB71pOfL4/6lWg8tiLljume
AzjMSiUb8RWUYThfZZ3PgzKTtWNUa2u6ZjPwzWuRK9o6xGNqhMlX1IJz+fJPuLIT2/anyMxJCCXj
pKx8AuN2yGfgt1avLVvdDhJb1pXAabLpBW4Tkw6mfK37cs5cr3K2qivSZNiWPUlLFaVtdwB7OybA
VJ9NY5yGx1Z2LZ1MuZIpwr5kBW9/9JOizpbebfBtZVdHIA9JK+w4IyimxZJ230KY2zklRohNNpvJ
0o6TRrS9b4EE/h6KPSBUnRJGxNZzTZ0CFUAhYaRgDAa3Sy+GXYi82UR8jmGeuebabDOgW2Pesy0r
my6rq9Pc8l49zGGs33rp2LGHNIDvAuj+05dqX81StPvcDjnzev9bNqLaFCxEqc8gcgbfqg3U8hOL
0vG+hX7ul2YioxC0c/3r5SlyZROIrCOv31rPwDAOx8bG18909QKYnTZTJnP4innfXv4jV5apLT2b
+oWsvdFpOQi0CB5QytjropKMEceJHl6GNXTEy4YbYlU9rPPncKfDj0itbmpvYsvPUonUaFWFWEZT
/WaiekYHjfnhNjRWUDDvuxfDfzwtQ7jW3NGkSb7OAPS43fts9Vka4LT2oWUpa7TwAco47LAyV9kI
lYnT69tENmRBQj4CmlIacDC+0yim39KBrJ/dnm6F8bwFXBwsOVz7tWl+rm3f3c8sdRMowTrzctIw
8FIggK+R62JdBVvbFpLgHMYAcMBze30rlIfdntSZwOnk9Wjbb4gMgXeGkbHb063IoILPaccW6DlF
p4oO9ekRJAy3R5PLkckAPFgSf6Alm8b+LpHTA7wbYscpY61VUg+6WplHS7Qobyg4BNOnmZrpxpQ5
p4ef2Xsjaz3x2SSkrjdYRI4Dvd9gPfNPqOTsF4SKuwF9GsJsH+slYGDk9I65alswhr54ML3NRMvU
28xD1kepzje9bW4lq//1Kn9Sztu7KDaStBS5cDgaw1V6p98XHvT+0el72zIxkNuhzEgxaD7yKwUh
kyqIN7pVr4mtEpsiuB2HZ6kV8UWc15v4JQN9CzZ15WixRWJ8D3F6Cjw8gpfqmOul0zDrnZLILYlj
68TMImGUodE10Cbp+BbAQJPTMdz+cht4a6GlKKNGa5rGJYyhX4OXbw5BPdduIZQtE+sNboNbm8Sl
2PegBF+RlwpsMcenW4FDvDd8lGkUl2BhwykwIn+zLrvF67r2Va1V3CgyCaKCqFx6Ph17XkHrRla3
26atDRu1iHYFGE5J9+UNI/6Yz2N9S5H0rybjmQ3IloENEyLuWrK4XMeIixOKnupBxTDkyEP4F38A
z0mpnNYRrIqbsPNYnsawQT2cKyARQN9jN+VZ24kxTxJtXsOoYfByM3rsbZ8O/pZ3a9rWbnksG+vF
kTHovckgQRlDtta2AMLiPujWIAnY3eUhQqH/h/arjstpk3c49r500ez44tbBir7UbDUUmdXNsLDM
6mkp+4HeSqv+K8B67hNaJ2vsD9MeGcRkKxIhyzHdu776DojbXBUpwKFTvjRe8K6B5zZcejmt6oe1
GXC7nc9mY7mCYbh/jINFxwcPemp9WGFq+jEMla+O3QYTYFhGVno7SrPrnz5Jk4MXxu/0grAvDwav
/5EMvS+dVIko6Fx+hcBLkJ6HC1wJI/V6KvoAsMJ8IDL65+Ud7Pw1nxkru4DtrdNQjxsSigbwRC+v
wzpNisiY7O84EdGnHTWNLy//pSt7gl3MjpYWTMZa0nLthvYurhf5V6YC6VjAsqvZgCkmiHZC5BY9
GKNTYPaRp3NsZA/tavaQjvPe+yFO8A0TtehUIN6ki4/bp9Pg2FpC2UDrB2UogioBb9tG6zoXIXXM
u4ZWyNYITKCsjWgp5PIrwKLOkZJy60sitpiwO+d0KxPTMq5Ylfem+pgF6S+3YbHOEZ4o4mcSGZY1
pfOrAWB9LEk/LZyebusJkSsOg0TKGDy1Wr0NlUd/a7jIfHd7+jm78CTog9dqmxia4JOuUfhz6/De
hwpCsVstMte2OVtViDbUpUf+IUbBOeGPpNvW7x2Hee1xqFmd5QHktJ8gAU/f9Jrv0SskMQb1tacD
wKsave8fuQmHN22cjvKA3MX2rpdV7R/M3sFuua721CtQc5xRqPWX7Q0sJ6kpVraK9gDFhBgOSgIb
dGP6XykQh7aeA+riJobrFcU21yYQI8eV+V2LMIpyaHX25L4yFWeva8DCvqAyZB4hgxHoU2uC3k0T
S2wVJbq7qiZiaNUOfQ92tJjGCnuh40yzDjxdMQORWJiUHZGeyQPeL0ER1I2j/wcJrCNPwGEXil5U
VmYVRaUAIubYpjJxixVtql7WrRU8Pnx48KZA+PXADz/AxLJ1rMzbWsodGEAEXecsh99Wv7ZRIsWJ
+ofvRqkgtpoyqRYJK2JNESJFSY4THNmavp4cB8fao0Zoy5s9VnHJagS98Kashu/1yDq3Erctp9yT
BcXnWZ39j6vpntRUFUmsBsfwwtqkRtju+FrN2LxhWF8GKJk9iMmxeRJUgsstEA5lHKFQGuHmqCDv
AE80h8NLdXh5gz0vnudCl3NI82SDTed1EmrAtIlmX0aFrgcQk0N0PlcPHV3i3y//lWthi710YV0/
zRvquUs4rR/1WtcEhOigvlUvvpLwsMWPoERSwzscE1ImP6TQHORQX/h7YdA5WOyspv8kvhA/O4oM
JtrGEZ65/LDQVrnxtCWIJXdaju38s2XZD9k7QhhDW+S2eAFP03GjJVSw7C2gzQOao2ffacWFf0DO
oqhHzIpwxixB/ZhGVXBaatod3cbF2krrudfrMASkTJdsfbPVrfyYpaz98vLTn5+0oS1vQxaz3Yeq
IRCVjHwv6roR+oC+EfV9AshbOyUAQ9upFDCqpc5Ehd+AwDJnU/MxMiN1nDhW5oBHFTVttZKStYId
q7bZT8EYuZ01oS10Y5zpYAmGqGRxG9z1qy/QUOm7bdahLXMbQagWHudRqda5n3JtPHlag86xnBza
QrcY2WLlVXj+mHny9U59qMHhNHcjTHp+LwptCRtoQnNQV21UenKNIUiK/pnPHqQvz8xrD7e2U7w5
yDISB83WmPZV0DVNTqSIb5Tszlv+n5t1aCvYVqF1MKxISfuz6E0hRTfHBThGO9hgYTpGd3O4yG/1
GqqfL/+cK4kc+EpeHg+MwQXNBCmBZD9AFqDZZzrnOzpAfp9TU68Xkfbd+b6i+HIXaBaPLTiYSBAe
CPPJnBvkmILjTIdwzc0gOvFhSaf+Vcdan+eIFpPtAd10KIe//LpX9gVbJ1e3tTm7HZJyGwKl8xiy
m88+JAk/x6lyo4WHtlpu5onJen/DrgB38sMUzFHhDYM+vPwLrs0fa1sI28gThhpSmi1cT5Is/XuK
9ky3PT+1oiy+pQnIQX5YgnUyHcCZVw/DJBunMCi0tXLbSCo5iQhPX7nJCQ+b18RzFNqHtlaOLFAO
xclASrBUyD3psvB9arJb/Tbn9fnMyrIxaWuLeokEW7scxqxH7mboxq+DkbzL0RqziEPkx7Obt1X4
h3IO5JR56UlQTkZg6sMKvP+ZrmR3m0K2di6uFGs1S8IyrcEVO0Y1hRPdqPh8C0N+ZY7a8rmuF9j3
z7Noy7L2BFMBdqghrXB8fXK54/SLPyXVTHzUC9O0qKM4OeBjuClpQ1s85zVyQD4TdvFbnajjznx6
4P3kVoEPE2v18llXc4wifElxvBcogQHJ2UdOZWykKy8Hhns8mQ0sa0siuuF7C7u+PGFEfHbaeGzl
3J7WXdQLPyhj2a6fkbVvX3e6v+UM9Xx8HtrKuXVIkQ8Rc1BW4wS9up7m4XNSRewv0DEmL1ezx5bc
myv/k19P61pWIJs6aWxDW1bXkJDu7boFkEtuqHaAAFqgaKzu3YbNOu83GvXR1qqgjJRoy4nTO7S9
OcZZtqxuV1Wacj0GZSeX7VPUtPRuDalyC9Hj8/J+cvOTIsF1pser8ypp/vZFsPfo7gakwW1krHVs
aDRoOIDgNEDK/4tq5wXtqWH4w+3p4eXL10u6johA/BJuyPyuR84ARcPODSAf2oo6guM9SOLUL+cG
YswcNr4zfCUNddxBbUEd31MQrYLFLzcesEOi6w2UlcxN0hHairqEymqGeikoIQNofo51TFG3cU00
hbaeDjZWVKyCBUDr6elhg2dSOQet75SpQX/K5YdNaItb6LDhw3pj8llKwn+ZrlnrG7PyyjlvK+oS
j1dj02Oba3pAK3Pfy7jOVw/Kply2c/sdGdpYuy0wW2BXR7NXgRiFk2wn+z14GPubalpvaabOyaVn
IhZbX2eaNoB/lOeXiM/19kjCNnkbm2gHVp/QtSrYkgzT0UcTSniY/o1VnVaeLWPr1r5bx2HwywZW
eW98YqpHtdTSLUK1EWomSdbUr4BeB0uteitmOA/wfd8cJ5d1Pi9NX4EW1gDsnizyONH6J4z3zI2p
dd43n/sg1vlMpwnMZ4N1waJ1/TXvpv9EFb/l1XDl6baIbRpSMod9FZayj/wchoGiyOLhlowK9mHn
13zm9W0Rm4fCeg96a1jW8OOUUAOsYqc5uE8tX3KorLbpqCv4sdz7O3xUCqq7VZ81Jh4/7CaMzccF
PGZIawEc+zvlhqi8iXYkH+iWZGGxy6Ffj2waYpbDibaByo+auHk0mViaHJr6hB4yNTG/mBN0OhXI
1i1ZEU9pssA4bmraIlVduBeVbv2tnNtWqKIVs9hLSlaynLIKGa7jstElzSkM8hZgiJdB3O2kh1hl
340vH9CSuspXks/jUnQtqjnvZAUj7hNtkBE41ouB91kXxjTOG68Nw1eLqUGzrav1fyi6kuVKcSD4
RYpAEmK5srzN9vPa3i6K7vY0ICEBYhHw9ZPvMhEzEdNtg1BVZWZl7jUYy0HPTw2CRT4CdHnTdz8j
mBp/sFjqnM2erLlRe6D/8iXc13w0S7NkBv6CzUvajEGTBRuNwqPG+OszD7HLF9Ss8HGKpqHlmQz0
tF3ibccBRVwd1lNepaVwItPT3gwnEZNA3vGe7Cw3IHH2B4E8NVVswb7J39b2N9UErviVZatOkxSp
Sdrp3/CE1//hxSWyTDlz9A9lcpJXnrQRappQq84GMhGamSAIMZ/LcWgv8wQkMF9h5BycYL/PhzOF
ZWiHHzFwSU7jyVi0ORH9jTDGcMsJUg7jXFWEvjBBwvTJIHrqjEBIJ04bTNErxAfyVb7vLAyWB8eY
AikLNLARF07GWeZNVwVhgbgh+9P0XtmyIr1K4THW0Ok6ash/82BLF11O6CUeK6+R/UWnnW+nfd+T
JdNeyqmEW5nbD1M1sE+q62i4VD6E1RobB3Nde1m/4ydsoOeqYBv61Yfr9t7U02+BpvS3JvA/KoZ+
wxfVb8y92W7eXszUhu9+GydVsi2EWGXmynRZ3yoCK2cKl7isNREr5jgizynsZk/thGkCIEc6uHyY
2PbCoCVhJ9lMQExGEXlxamtrWUGdACoER7JmzJp6a8Ajb13UnyLq6geEQbf2LYRdc1qmQz19QCtp
mmLbIjV9Kt7L5sB9bLfDkNCEvShpFnZYeyXVQYPHxKEdA29fElYJeuZItlqRnti6sViTJICuXpC1
KULsTpPMjOuoyjThbjt1blrbM48EjiTObtXAh3qiMs0T3O+g0one+qytY6CUgxqRNLVOqRryJuxp
CCFI61lBMPlf630ekxdvB3UZkiTVP5tbWHzoYhOou7BG4AjawXoE8eWifwpA4h82ROKR9tysZbzj
7Z6S2cwPVbhFeJ/7qobSbWG/PC97yOYvIfBocu0g4UU0opu3e7sx8jXHeochBJzlo0ckOjcm62Bp
1WXG912Anx7OFtd6QmJmITy+80OazNY/tG5KgwIvUyYlHev4R3a2nb82EKuygNItiQ80df19nM7A
IqGMIL+xAEGjvK7WFqhW0/RpwXqa6jIg9XKPtCdQv8TA///OdE6nj7c8X+My1/NbeGY1YHtiC934
KvAI6yJMgpbkYwWV6d0271ubL9G6wmaKEv5ndvjEsaMz3G6TjkZ1eXNzHA6+xpN/lnvjwxNHJO54
F4X9e61JaZpl+x1UA96LhTGoL5IKyQEqi0R3c93sfMySMpxJiPhFu0bmAgPmSuOVJdgImmGvsd4n
M6VgfyRb9ocBedh/kjWZp7sGsvLlQ83Mzg/KNGo9t4QKP96qQ9zQLOysAwyc1BCUBrtsTb7G02Ly
aJLRRyIAWpYkMO4nkNoXMwHygfd/k8ZMpW1lWqzNNB1j1iO3fYI/fbR33zcJQaZmPuS10//qAArB
DDELUP0n4lPCY+/AV+x8WuxjFc2yYIRM+jQPzNzkm15chmlMPAOmIIX1kDWvaTT/2SZh4XfiPxzi
y1gW42O+epoMORyobFGBlc3b2qMdTIgocWTqCo8irDFmm7i6UzVZfD67iDwipRTy6DHZ8Vh9h63v
bAzCGs5BkBBkkLDPJ0d9XiEQFyXAVWXsZl4gt+0XKlh9WV3H8gCuilVWVenDvtqpyhB5QQsBtnaB
yxx59XP9m4VU/kaaEHuO2ggJ6wvpsy5Auak9w40e1E0emnF7GcZp/EJo03zXKxZ8tn09fvG4l7lr
mj0Pwrh7cc7gF2xJeuJ0/bRr/DIjdTQzsTN5GNVRAScYluFQsksLbRRk+GsME2GlfsG8IX6kS/dN
TAPIdjNIcFDev6wGCwBRSsailvBiGXoJcmpKT3oBFCpaSA44l8+dap95q9c8qcLpSLrpfWj2b+EC
Vq7YAjxa+EtmRE/jJVIEJ7w3zX9kkiLTtnpWUfjbTdEjgqju0jSaDm61j/u+plO2L0HzF2Y4bC/F
rNNfKg0roETwkdmXpRRmSE7tiKBl1YOv4cPQ5rvfzX/4siOa79r97bodHmlBYi5oTlzZ1u4+2BIU
K8RUfIUIjP2Wc3/mbH1sjVtz2gbhNfLtcQj3Z42VzzMKRXAfR/V+WARzWTAn/mVet+XLab1likxJ
jm9sfpAcz6lG95HZRstDF2GSCeo5ztFs1B/SbNuLBc19iQmObwOP6GKQXZsFFRy/l8Vtx6ln33sV
4aH5OhNpO2YdN4etgxMQh7nikfd8u1KScqw2ybHKIMeb8opR9g1LpflPPfM/8MziOcQq4zHo4w9o
HdVppARGKwimP9VIT82wIrufoq3vdRaHcI3Gh4bHM7GvukkROILIBRy6sXmMpdriLEmT6ktXKGhT
NE5Z3VuXljgjZVJ1rqhNza5TUKvf4TAOD3tEWLGY4BDG1XANGZrJaWovAo1aTiPdl0GkAsRyGbRI
bAk/RpDcJ2frNWsHc8ZkLO6l99emJm+6ZuEJH09JKxGXm5+azEi6Z6sIWK6H+uIm+SYrveQcMe25
puuYtcgoBEuhmosPAtzcM/8M7fybw8Im7yE7bDNP16EEZzD9xi6nKbqENFU2+2Y8xRo3LdmS4Aqz
sfiR0zpEodj9xw6le7HU3YhsHJ5mU1O5Pt+32at8Y2z8r4HuoimCeeya3LdxXSBowmYTrABxt1jx
XYVrUh1XMGYtlDkVD49iJtOQO0raE3PJkm+1XDNOhchWtAU525dvzJJTCI0RTaKswzJ6C+kLSxxS
W9Y7ocbQFkbPds/TJVY5c7gS6Uqry4w8pvWKdeEmgygxKgKEhBbzTb8JSzKGZUF+aSStj76TLq9t
8w3PJZ3B86SCjWFMizWe+dsA77K82RAxhL+Exfup55LNsNUPw0Pq9HAnzHxdtvRXs7fXwZjLjLSj
U5Q2k3rHrml6j34w7J4t/DFQ5BI/fSKC2W95sHIz42vpIQxd/HNf6U0VVA4oDoL3KSx5E0VLA0it
uV/2MT3YydGHVllRZ8gmipKc+zXsspDYFJNGytFfGNw1WTPB5tjhUdxLJGp9Vm6l+YDO/0Wkicq4
D8i93ZOybuI7NEDDA+FmrLNwGX1ZB8nnXI2Xrp0QatGiSdPo/R7hOR+WA9mO/WjMI6weviYO3XLa
mzQblz0eMthZJPkSaAwvtgnzWMQjjoYY0SUFwSWt4oGe9tCQOBvWoLtgOmEGUlqx/WtgNnNcpbFD
od1WlYjJGTLC7MYPi+YNmtebJXqSVPrQhGGfzzq8DqDQMlLVbRazQR9cPMTvDKQg4qyQOTrAVCtr
ZYj/C5Nu1m4Wz870U3Cum2YsJCronAdC7yfHcE5hSskFNvCM/a/ljWN5Q6vuRe4KCInADJb1S2rS
Qq4wEjg7EeunXa9zmc6rLFoLH7tha7qvLjTzfe+TGWFRukKaw94Xli7jwbUKTRC2CA4UoN0vy/rx
hFvDlunY21KjXpekXpsXTVP6TNFToFXciM1JHKfnZu3ML2SNQ6iG7FyknrZ9c57DyT1hRlseQkpR
F5M9sRNCUC3PQ73gES9NEr4ubhr+8xM8WwfdsRPTvA0yafv43KARv4eBLM+bdQheRuP1kWuKBZkZ
B59Ciwmb8n4YsnEVNKPwYnRZY/vuJ6AYadN9eRNrKgrlVA9Mx7YXaDcVtlZt9d5KWHtiu6+rg3KO
KYmySGn1d6x89woa0tw7v6A7jsfxwmLb4YhV9ZSlCSXndOd14dVKLlxO6mxpF5dAaBP95Pwwq1Lb
OIpxY8crdECwT5NbWNUFvGnluxeqSzJ8ltNXutUIhEUWU/cAaUrzy8sp+BS8wrOrXWvfOR8pBmni
CJr/iIIlZe1HZK0rlvTWXY+mjfYstlN0DqoxuhuWqv8WFYh+zDnomzBVJqVM4c81GnjQE7jr3feb
FdNJjrPNmFVmelg5HFIz2EuRfEqmRef1RHZUJ2Uk5p2IxuAAJOYnvqaYX/y4XNbNJlegAfT3LRIn
Q/DlgMNcaY9YIVddlpV2InM2cu8oOkmfR9EIiSV8Mqs4syn2Eo2fuuOKzdAzrrjkVdWx/qAt8whz
IA9yhAg/c+GONPqV4gaUvY8LPaa4McNhtQeUYt/nqpmvBLrJAk14+h+2boeuxKkc1VU7jr2p2z5T
7gcABhCpxyi5LL3inPzBSqdHlHz61G8zzu2m1lJEc9plautxw9Xxrt4QJni3GwR4VlP3MXOACNm6
BIGFX5jqeUlDzZ5pzPvla2mFXQ/IPw6xzqYp4oG6Pfe+CZ7W1uAmjtjQzIX2gcCekp/Yd5+67dOT
atHZ1nUpwcUmkbXomwqTiSTVWy2aDTAIJ9DhL31FDgmP0j0bdzFeazbWc+GTENMg8BARZHEFY+Js
AQB0CDeCXHhI0Pp3OexjESuJUBgBycHdxlq0MYyLnw6NSN630pY1bparXpjG+xk5UtYkreJTEsrt
IrFg+L6AXSprHi53wtXvUCAld30NwEjjTsiwPqZ3mMsByIHXzVB0MOo+h7HXeEQNq06m09URdUQ9
LLuZiohtthjDKjyowETY1QrCKpOezOVknL0OIJlyNMn63UWsPzj8ew74RRUecby3YuiAMgTMfAMm
Xb4hOHTHaDBVwUdvyg0XZs77qToDY8N4twFHBfQCQXC/3TzkhHtWcIIo4jrSr43sB51BOl/3eR30
7wuSFDK+LHuXwbo1OiCmbz8MGjfyQse+mGnESwOv3vMyzyybcKM8imSuMyiHccLH1qsMbohcFxSX
bDEySc8ydOIftKPihEYpPesegyP+wOdQ40eCj70r0AGKks7NO+ZWdnB6jp+jOHmMbV99kN1+zqEC
/9LqQphohHlUK9+QNqbO8Ilqp6xdEZKaKdgXo+0LmxxrGBh24KWX3NUTV7mKkXzWMY9b0MO7FMid
fYD7i8lYrJZ8miF2XHWzYYt81n8WQbt8RDbAHWETO2gSykOksPExTLL/qkaFhnpFektDKlHstJ5L
mDuOz9aM4qlHDf6FmEHYfg3cnwYGoGL38hS7urkqVxvsqMO4aW2Xtz2kQRZCaYY7PGwvDYLtP/qh
KS2az1s3prO9GaOSWkzsE7gE3P66wNgkMGw1z20fuxzRyXW51vQniqroOFkckYYNJ7WyNGMcLRjd
26WEveq/HeazvxMMFZcoRHpaqHWb9SKwJdgE90hdfFRarLmLzdc2kOWmvR4OiITmeduJJiPz5stW
8aWQE36tQPHtCGSennW6PW1ouY5urHHp8u4uDsO/m/HzsWuSxyD2+A2q/mluxDUOMSh6sQA2ishX
lYrgGKYKqCosAq/LEBkAI4C4M+2qoyQMSzjJjH0c7LC+ecuvlN8aKKFoDvdmU0Kl9BmRBi1lor/5
kkw5neI/jeqWgiFM/BoG2uMrGcdMjfv82YKqKeMNG1iNZrnfOpF7bCAdN2t1XnUTDG3XBE6ifG8f
0J/gnaI4IIh+D0wJGABdVycwS8ASEC9nIjD4D6qD3NYkNw57Zz1cq2+4KM0649iHIsFwCXzSFMgP
tBn6hw2aFfXlhgpI06pFOdrwsV802lJl3+jaf6Rd3KFjGFS+VKyFJrCyh8W1rrRafreBhqg4CssF
TpPXiiGqkSz02SF25lmG0VzWy4IOrtYqsy1i2rhLDqRa0wKB9MmpGVqa1VR9KdmLQxz5lecileQj
wksAVL3UbzAPPs943VlKIAHGkY8ONJS4D/rO5CNrhgPcyV8S0N6jqky218tmUcPb5DIjM+0pSHWa
tzbAlSQWbECtdTecR+TH3w3pIMpaVBiPOgejNT+CNpSUjbnQw3yviJ77LIL7zye6nW/0rPoycrVd
ez6TPCLbdodtp/qJDsOI+jft+OWAFHcuI17wK0BW/TBX/MP5pH2ceBWvN6zYrp8D9AC5Z1biB9f8
Cs83ny1QwmRQeizfq2qw/xKrAY9qwiqP9wCrR6M8vxiZoi4vECsTQF51/CQqZAwcV/hNYIt6mpUC
Ci6XZ17vY3dYlR7ZT9XsLiddwtnFCj+zXElge5lk6HWyqKFpdzW+8fV9SEaWYfozBd6swyeImqu/
bykk9XniMUKGYVRu6esSpOrPJu0Sf4Tprb3IfCuSa2fpdt5UXC1oU1AAvyfTLuwCHH2Jc6wk3T5g
iD4PBGmqO5aX5zhEL9sFfRHSBePoDY57j7o5dgXqVwgFniDivqaBU68yjlv7wmEUuR7WqurlEyKE
++NMFGZkPmqMmrNZBv7Q7MJdZALRNT4E8RQEczBnKaii+nnFKqIFUufNwxCGbj5ujE6uGAfXVZeg
2af+1QYz6myrt9kdRx4GKtMrW+XXKEPqSkCg4FfaafgFoQvDRHPrsrJVUSStDegEuudgZAIbjtjL
e4TJEyw6M3A6/hDHAFt/xgm573drQ8a9qDbkHmc12eflH9U7ijC+kcgfkqZxv8Y0rU6zbLsXzbu9
u0viUT1WqEr4MCJRD+eJuOZt7ioM/2G6hW+JMdGrY77bj9Vy6y6qJoa1L75GYKJDNHjk4sJaPsRE
t6bhk4km+qhu1vMHF8kO8Pu0dhv8+qCzP8d1qPQDavegT6yHi/HZsIaecL5QvewCJZJqzPLYAi/4
29FJ3WMtsQej1VIsLiChPUkQ0bppBB9gXqqzObJMIeGhVaownZD2xHFbACSFVvyEv1a8ekwy/DzD
15UfSRR1T0yMsJLpZrlh0f3mXIwbSg4/cIKd3hTWw17cathaVD3eEDh+534mMQekwNjNyBNi1+OT
0TQGRtSF4tWFlVX/vO3gf4LWETk6Ek6wYybx6Ntcxp7nabiCgxiUqTw6tV5+NnNn6weNDOCwSF0z
4DOpibN3lmh1SYdB37fwgQxKpKj0c4YUMBk9xdG45G0w9fzak9BNxVbbtM97Uv9wkB4651SqvkQq
e/2SiohjW3rQ2wmDLKPZLBgAn9ml8NBvUdwycDX6X0UZWJE67X0BXHv3hfR6/TdvLn7FEiTbDgpk
3EXQuiX/DAV+XNbp6LAk3ajmGGMR+6Ix5Q43IVPyHlhwjfdbM20+7/lKp7/d1kSsyhKlvLuSee/I
OdqjgD9rsYu69BZueQdjenbBXR0vl76CB12WUu9svsGrUuRrxOMnvAyhwbUEAxqRNsEmLkw0ElcY
JV6QO+M0LrqaAmGgewh4jU3daY6GxeYavRiESYOXjbqbQhkFPwEw5ejQbXOV3Hw3YbL6V4D00Hcg
Twb+TAgQoKKeWNs+2XYHRbii9hwjG03b7feoD2K3MWz+wgB3p3Ka2zxCmvk7JKXbB3zizUOy+OQw
m335BUECAOwRxftui8XY5Vjja3xGrLSI+gkX9seiZXzpwZW99cts0nPb9AvGexrEwYsTbnwgm+hN
gW+2/g/vYP/0KhHxSUSEwOnRrjZnRIeP86q253YFz14bTJcZMQqjBDOcN2eiJbAmYPu1QYcKwKYw
VMXvKR3nRzT//Am0kNRZ3ahZwQt0SYcP3q9Nkrt0tzKPAOHemo1qGf+jdF3IgdMGMafpxNLnWs37
McZkgODtGvtKpvX6GqUCBALdh0PgxcZxa64JoP2a0j4PlGjJeaIxbUDbDiPTgFh6TT5stDC8uw52
qMjmnRN5DzbZzE+bozFQ+32Ogr+N6JrvFIDv/SSXmOQpzC/Cu96yFep+4NYqXwEhgVJUCXvHHDe6
cmuVeJtINJ43TMDbMY5U+s47j7EW3kn9eat2Y/5TsOWE7bN1N7IXrMApWIMdM9a2azTCiajemoG7
TFIS1OUe3WyQ+wXMfLZ4Ob7CXmv/neKfMtsrMfOMY6/7Z9N1YI/ThFNbLmhTX3qgEJjVdOOyjWiB
f4p1oJcKdxiugC0BJNbjnlYlrK7bIG/VhjVsiAa75mQXsb16X6V/jNJo3y3z0yv60PqVyhYPQs6r
xUIiiNi/BqqRJtMoByP4+CBJS7gAYroTISiXtpLdWXrs9Gdhu3VPmOj3Oyf2+M63HF51iD/RghXt
wOWed31L/8MulKgOzPe1RmLD1iLYD0Lyn9rY6S/rejbc6HU7n3egqf8NVipZUgNI+jBSTLBAmg1q
bzfqAKU2XOlLawcA1zTuXV+AT+90btMI14XhBKVpB2MvgVQ36ZJVRKYfAOaq6q7SuD8AR3WkOkFP
N0D32XiKwX6o2n9zpIY/uttRAsAGrj/LAMoyF0Hvn1mz+eQexRNsBp0M2EDeUI4+dvJnQox4cL6r
54tzVIV5TQwidsZpA3dEVaR+9WDoGE40lI9HWHzSveyCdvwRQD7/EhNzc5fC/1kW21gDNyaNxR0O
gLWqjwGHMXGetiC1c3yzNCwqCzoMbeTe/DJtaH5PdumDy26kTg6yTbofMPVLnO1z2uZcJ+znNn6k
OST4Zsn7TvrHYJqkzkeBzdAcRDru+kBO75GB/uIwtMlsjnImKMuhkD08kfcIIDAB2Y1uK8YuaVEF
3ujSwQiOl6sFAFaiOzdfK2jmDLdLCFZ7NP0hEdrjplWrveISJneBJ2B0k2X9A9w47XIazjuAyUD2
r4gdxYkZxoDgkfolCo6Ojtin9oLEFcC4dkzeGlgPiDMuWS4yGpEJamzaqF+xn4N3R8jc/o0HKDmw
kLDvI2ALLW2xryOWv2fTJw/7WC2+oIOcrqJOlz87sIM93xq70UPnPCZEu7YTCGIv4H++I8wnxw4Z
JffrHKwYf4EjHSY7b3fe4X99BHYF2B5rayo5WdV29l7jx99wKyp8EXXc92Az2h5ij8HiZGAuX1dE
TniC9MoFfabFnA2bov9UQjCEDWO4moysKRUHm6T2Z5YCcEAAj5uwCHezvIE89vwQ1HpZDjdvnaog
ezxDIcNt/w4r42o/Sqys/q2WwM6ZjlLHymVC85bDqNK2zy1tRvASugHyRxRACRxrbYHJtAPEvXgV
D6OmzX0fGsjcAx3JLRsp1szO496PE+iRAX37vng+lElt23d8H0HwtiQb6/CcEpcUK8ZvlgvGOghK
MGZ8JHan6WnyAUykmgQdTSaxlude1m0PJ3Sj2vf/aG+29IC/wn3ickMydq1acFaDGULIMuLKxyVc
6TuTwSWgiaHgESo8UDDQcw78ovs7cs/WcsRJWDJguUjHCDyYrDKspqgrahLhsU7x3qJpj/ftb0Ur
Lh7aAUMbxs9+2m/QVLTO1xiw+11qwYLlK2d6KtsKhMcx2GT/6LGb/SuR9c0LZJrCL43xdDyMUIUs
xdD2oitmTCHBB5zqpvGZdpuP7+rBh1hLBkgbigOZqg2ztx1C8wv0uMV/6aPE/JC47oIrWIDEHzaC
PdQOHSn2pzLgAihMPOI2+Wg02ggoTmCMemk3VJcCIW0hBv0Eeo88qlBorgZEOAEf0pApF5ABVg+b
Irg4eUuG17C14VfH1vkbQlB/SnVXx/j19g5aAsbMcvbUhG2+bSa+EXNbwv7WyiwcFX5CR7ej28MT
OvJGU7dnU7AnprS7ZkmBOnnjI9rhCbmYw1tja1DehLPh6kiDHzrqmroGJrzM7wOp4Fc4rO59ixhv
CsSZuP2cVKb/XKs47PIqWOs9xwvHVYog9mhFi26Yz2FlAlFZsMwV2j0fhuFzTOOgf2yETZbThhs8
LcnUdDRHBegfEquSJIuw2vkDLMbLPEZLDgBAuWG8ZQWFY8HmtZ/uZ6uaR7XHgmTeMQy/HtdtgSvK
7neo+zjPAsPilKkIgDHkfOmLhzpd53MfB03etNh0yLp1B3zVcfSql9SqAMD0tpjhwsYZ4yBGT1y7
yd6vbQYMCXaFXY+jbSgJsZ/Yju1DuGztdqzgl2o/JwUu7wz2EEUlhh5py4DEUlsmiVyCW9LG0hZ7
2FJ6XfAsYM8tmUqzIBmm5dc8w3PAZk0KryqUDRXVT4gSqaDFq6bpDU5T9LlPuH7SSe1/41GhLRZY
G5jPybzVGp1CH/2GiJBDphCJacNe9NhHJbjQFDFiG5f/tS7agtyvdS1ygAbxN02rDfSotis+O032
+zFchvtNKNAn0bw0Zcc0+3as3V6D2Cj7Th1ou9OYSvyRwBhjd/IBIsT/JbNqsWgs8drKMZhtdFcF
lq6PSRO4f7Nw299Ed4uEwuk2pxPcBdVh7hhbIbcLdFtMMWeFDExlSwKzmX8JDcF7R2PYkwyFNviC
dHDHz2hUhPjyWc5VjhDF8LQpiXyuKNbHhIt/dvVIklkiEvSIYyYoenyEH0nGYfPACw2tR/8kpzFR
Dwyfd1S2Kas+kEnTDW/JLIGgW4QyikIHIb9DBzYEL5DKoMvN5Cbqf1723bWKWRoWu6tQ5+zefgRL
yLu83lZDSuvq7TWGdmDBL1FhOqmqTpkyRBRmVTC+izjvo2bHjTDwukNcn7Au8zYC5ElRp+qMgh8V
gKSjTp6nieivAKTlms3joCngKz/DImZSw1q6OgCp4/E13jVBkK6lmhL+ENVD++F6hqY+GEHTsyCW
OwR/G1ghv3MW5AIjy6tU48bPioy1BLszSHmC0GVH1xZTBhq6Aif5F/sVHXDkFMc5D90u+EV3t98C
Y377YlYSPQ+pBuYoON5PIFXRKdaAYR+X5NwriMbg+jQNeAxAV0sEqo8eNZzHDijXyvVJk1k/oOWa
/GGBU3eCHzKlf7kUzVvvOgn8YiUOwF4wkgPqTmMPbRq2ECz0WCAqwVMnH/VSOdD0cTygFYPP5wBC
VLTfpA/m9/Z/8s6kOW4kTdN/pS3vUMMBdyxtXXUIxB4MBldR0gUmUhT2fcevnyeUOZVSdCo1RZvL
2FjVRUkSgQDg8G953vcrzyUlsO8s3+bhnIcMQykpTcaNE9VrV/R1vQ47zY6WJr2EAG7FTNn4Wqt+
QH8AWxrGTX2+7qT5D6kTVvdTxzD7W1+ZLGvHYnjWIpao7hYhOEm+tNwqeiVua5m9ZlZc/laFhOuO
FZJqUzE0phXvCKr6oZPEVIQbTX4icpW0sfxIYXvnpOK9T9gVUT4UrUmFtTTS9dza43XOwPXYa3qj
+TzAQz75nSky6htmu5QMmpRe1VdMiCgMP2mXSZQTo0xj0dH8IoXkTTQI89HWWorGQVJ2x/OI7HhD
rhQ0jPum37ymMzcX+zCvu3FJj0fSfExLqW8FsWO8VJN2doGf0+pr2IX2XW+RjIIiOLigZ/nMYTWz
5uLPRhq6nvJjudOYDlAd3GSyPDdAM7Vqq4Iq3IDgOls2TmC8akk63s9N2MAz1aKYlx306Wsq+6zw
Kksx9dBUIQW0bh59BtS6WtcAwc4NpRSRRqcQkPh86a30JdGS5pNf2iwkvVfAV1iiHIDc8nTVONb4
NWrqpifyKjFkaSa/OCZ+ahqe1lWaWLoMU+rXpmEX1SrotYJAjaDFWlPgGpt11LtpTpI/2+Vm0Mdq
pL1q1i5y/SK3r32n8aOrMGp5Kxl5pkbahrIM6FEnWcLQ0mG+K7BBiq47Jy8NGknSGNd6ErstO/Q5
1M5UF0ivxeCjeJ9Bj46/kMv+jCm/0Fr4nRJ8I/cshihHImyY9Wfp5M3rm5QCl9aikzaP46jTpWjF
nJ3tmPqrbCzMXyivvvmm/BWwrn5UiqCYZ6DmFOkbyydg3WkBq3TTuqAAC0abhdUyMyVxKSnw9Ewy
Xb6IKpX1MsoYSroOSbGyFft7bu9GpVlvE5tdzsSmixgVNtQtLxGw6ChMp6WIfzWn4yfalcuR2AT/
RuIoKiZVLrMPcTZUzyMl83kh26rED0dUlJvedusu5FVBWNlJ7przRgxjcJi0lHUna+P+bUe/kGEI
3Ryw+KvnjTEhwlRmr+90vYjepsP4JnD4Ttfm5pEeGEyu3kxxqa/0VuRrBoCJt4l6Ll1O09otdCfl
3AvhZlg+WtI2mMITh7+Q+P9kTV6OwtbOIxZre5g2NOyf9bRfdFV++6bLfmlwSp5hFsxDnTcsxY+x
666YJF287YG5tDctq64DjT03ABMrZS6nIVZ8jeJtThyX/qYjVIUq9XjeMP0vPhRBVa+rWb5tRI1x
6W6azGUaEWBMm6qpoy9WWaen2izCP4Yj/OfL+F/Ba3Hz+yup+ed/8++XopzqCG7n4p//fCgy/v/f
57/51+/8+Bf/3LwW15+z1+byl374G477x+cuP7eff/gH/W0q5Lfdaz3dvTZd2n47Pmd4/s3/0x/+
x+u3ozxM5es/fnshBGjPR+Pllf/2x492X/7x2/lK/ef3h//jZ+fz/8dvi7BrP/+P33/93LT/+M01
3glDWtLVJROXhDpPRBhezz9xnHe2cnQ0l4apS4x4eK3nyA/Cf/xmOO9Mw2B8h6HrwiV+4o+aovv2
I+udhbCF/1kOdT+d4/3v8/rhxvx5o/4j77KbIsrbhu/x1xOfme52sacEfu7TaVHGuUI+7AtFKSYy
XRrekVZlW8aJ1nuj0u0vAKoU5wDnnYSSGSM0F5GZifYxotz3XtPVUygpdJKelS07UDs2ydpmGikg
hbLD2xYtVIo83O7PcJMmbh1qduUy1FP348iwm08D8og7R3N5uSykFK7uCZPh7ID2pXM/D5TxwEYo
k11ldaz2TT8Gd0Fpi5KgBNnGggK4hcJJb51FAIpoL6Hky73qjeB95Rj+ROUfOonAMPQlbCqrSchy
urNqNUU3cIcRUY9ZpfSIa9stV3g4xLnXWPDzyy5tkhqi0ckfEvoAtygQ5huZF8PehE2mcZXWIOdV
ujBnKz+GcB6feiuY9kpK98oYjGhLYWHw0nLQoE0bxg2IyCqe/a7J1wz26L2KCUWbRITFkUlO44Ec
IlxRk8AKhjpAYKvwWNkZxXTRooYDMp+7japGYwsetegwClgygfx9La1gUTn0AhJ4xO2kFNrm1Iqs
j2mkFdskCOTVaI/INCpC9dZW91U1MGHADzpPdvrM8NGp9mrHBZKW6phb5vjinxsMqTFN1zIBV7PT
dqINq8mH0rHh0lVFLgCw0G9MS3OXmdNXT22qq30FvAC7OLT27lyBrhclIeiOes7Im6IXJ2xQjUed
rszanjvaeEUy386mS0poUQNdSY14D6VX3NyVRPogRD3epVXjFg0gRMgrUUsYMoTEhedHrw5V3G4z
LQg8jUkX5FdOuyz6RB5CqvtPNvWlZS/1J2Di/jCJRB4H1D5Pft/lS33GEx9rXdwQ6rKCEASa8fqQ
sVeSC0BQHWLHkFlPcRFZC3cI5da2KEPwULq2hGm1+3BB2jxQjwJypXysCIewTXL8AZSLL0OMXsgv
bZiT/g3BRMg2FBG1eOc8a0WS7JSwNUcQc+1ggpCk1LO7Gvx2qrNmGVWDbmwZ+QBJHcR0dujB+Hf0
0vNyPSvhc74+DV5qFZV56qaR5jJwLP2KNjVsNIEqpgSFWdSAMDATxwBT/fdUgmyggDTry20XBOIq
rZX+ELmWxh6ZO8PKaukOLSj0SXFXQzza/QINgdGutSoWraeRamn8ZRXsrSSxwKZDVewHyr7rPHDO
LJmQ2q0RgAsYBr6FOhM+WHZDpR9pE7RPgRuXx8hoHI0vWXSVpwSzPmymFW9MrHSyLfRfvhKDjI9a
N4SQJkN+SHtdusuCdgNdGG4RPrpMZFjjtehQIJjCliZEqD3qwsyPlOHqFq5Ov5OqMHgpVUznCXNJ
Kmbm7rCzVK92pl+Kr/bk+rdMXs3q5VS2xgMazRahIjyJWIZicuyVj3SMUpPv1ye8/wSSFdg+Rdu5
NBLGcHbjC/E3c/UcSlaLptXSmzBG1Nihm+8XcTQgdxmbxu4Aq1Rxmg0myBcW2jCqb2d6LgyQJwxd
sSutzFKLLh6whS3j1NbpAsXjwHs4EJ9a5yz8rNwh36MKnve66UCBtNHISo1BGG94uKYro7IrMIhi
LuNlYlFeWABouMuK3YVOPWLybdNH4cGk1XvT0ig7+lYFMpTmhSkWftcbV1Of6AJyNYlXeek4w8Zt
Mnvna4wwXTS4kF4rX9hXOs2izEszYe0aIIdlFqhiBfdGcmlg6nJL4kzX3oWE2QmtpwQR5050cDA1
vcocrX6qGA02sR5BFhaRP90VjfHI7Ivo3nKz8WPpWBW+MEOA+FJpxrb3x+H124b8/3FIco72fx6S
eJ+z5+JLhMfE7/HNOYg5/8XvQQld8Xc8cZZCL+IiBTr7jv0elAjdeGfCXLjoQM4lxHO48kdQIuQ7
y7H4mUQ6YCLcJYn+IygR+jupu7rtKiUs17IxFfo3ghLjx4wAbJM+I5pJ18QCUseF9CI2YVRaTO25
b7dJHQc737byeBE2jWdnszpUZT/c5IMKdjbE9LaFjzjYIOG3KFid+9GPwSi7Ib2hDGisAEmbF61K
tW1lszGivwqGRZTC/zLyRt32gDXLYISwhEVcd7VMf5Gyf/NU/zNl//ZV2Gp0Jg5jH+G6lyYPXc/8
pagKm23l9tEXs26AZEVR7MwByh1BEr2YaEpomE7qYPKtP4DlWPTWLPtWmXO0GSddXE8URq+dzNwy
I7zalkZTfuSNI1YRbttwiFG0lXWee9Rc649Dow8vzqgiJohZxY41Ot7qXRH9Iu2/qEX8/sWUIbhN
PEKmoXhOvvdU6eqiwn2VUndtxxms55h91rECXpXQ69tpnGifG3q9gQyL6Doy5CDurQRsRVh7yxqi
TRcHXfmLPPhHs7jzOSnp8LxIYSp53mJ+PKdUxwECxrVhu+YTajybloFfNsfBHYz1bIEJUgoMN9+t
qz9C6u9D6L/4UKUsx8XFmKdfXBqutkbXtWjaiEW40R+jttTSRTQDgECZVtZNMuXdFgIRacm//7kg
PZZyDVM40H8/flmcr1SQz3xuxba+ABNiP9aKx3iseTr0ovmEGPgX6TQ1sXPB4s/nGZWTEmQkJDOm
7dqOuDQOtspU0hNPh62dj/uC+LBG8Rjoe8Td7Zeujc0Xu/bFxwF2noYy02qw6Csf6lqGV1TkpbXM
WvrIJjt9txm6xnrUHNiBIgIwW8xx5Nabkm7OeR7gHDmPsBKxBxE63kcOmGzWNi+NFY4ENkR3A3rZ
JdYK9ZaIzAekQFP6hAcnbEZf7caa7lMUh/kD07TmlQnx/Smd7GKTWIH9mVYtWuUE/iOTQUNDhISh
tfOmWsisV1cGW+GD3jKkGvTFUQuIW6dZaDNt70aj7B9m8/nfZlCgXSucKVpia9l50CfjpuB9xs6n
0s+sOonS00U0Wtd9u2MsxKRt06kfPmlG0qilo8uaKXaZXd3hgZB/FiiTGQRR+6NEIWmhyi3yMTq5
PQ5/FKLbk4s13INWmiaoaA507g7VGkmFAAuA5/Wz0VjRurf3NIDSg45EffIy9E6jFwEXfynsSl/T
Gaq3gBh9vCqNcyLg10+JXn+QlUWfA9MqED8/KrPbypmQbeIF8ZAStx0KCgWwACYmMk7DyjXD2lrk
nRHe9l3IbOGsmGxUCFyFRiC6wUQCqgxPxNeGiVFHSROG0W626c0d99/OGvhXmbenJsr9dpGhm4BK
KeI28WZV+CD2Qu2DMPa/VDROHvAbVwc3g7hpxnFCi1BrJIBWchXbMhhWbYD4uwtF8lAEZzbLbaze
M3zHBdzNzU+ijYwrEJVlYkfGylWBvZpr7QYQo922sHbHaAw2ALTqBmlPu8jpSuwNicyFERB7Mo/n
KbGuqPV/IVwO126Qnkzc/jZzbCerXmsgBrGNuEOikq0D1b40xYzRJqH4sjOGe2r2VbAuYWJttoCa
8DfJHxzDDe7x04VWNpsKYaPTH/OuxDCijELDc+fWWXKbw7WdSZBQNJKdv6gYqIHcwZ9uZWzIaz/u
xhsaMw2Ci659AIq0nZXNzQCxzQpaiEHJGpylW3A33MnfBZ3Voj6bHYCM0sCPPYkDiIZKbhW+pvf2
rJvPY+xqW4JbcRM02nCqpeke6fx3S7s0h0VHI2Fj1nFhbVxNxDc5PYa1ActysoYaaWeYf/F7LaRh
EvqrhDfECUMDDeczWLg+mXvPyftoW5c6Vt3jNL3azQSj0yWfIpcoVuY3rd/uZFPonmHLp0qvTk2l
vTeg7Zej23dLf7LCB3Tm1T7Oq/YeKRAQeZi/VFPibvWMDWlbp8woRLrihq99GlSnrrNRZykzNI75
6NaWh4N/uTU7O0IeR1/FiZ1F3kT7KffrRVcm67TMb2LESTvhaCaAD3Ps7i1mXawQ2bB6mp4pH9Os
1vh7pB+q3o0mwD8sfEjpgF0XwBq5u6gzhz66EbTasjcHM13WNMQQQbE3rXjrFV425eEWvc14F/o5
PgQdViYsoJrEp0spQOf+VcxQ3Qgdl7uvO98yr4Qp5ycEXZbXSIajjbV+0ysns7Z9Y0K/dq3at0N4
MAxzSjxROaSoUaAjfErd617E7W0TpaS+jh+c8q5F9BSM+zFXaBSD8Qam7cqgubhupDad8M8d99LO
n9v+g9R8x+uEPCQTXjELRxbR1yDRHhqQyQ2xAQM0YjWvIEHo0bLZLoOqPJUDeddcFeoBQNJfyQ4N
t5HP145dcAecNFwbvcg2gl3rBRlXdrJM9HSOC37X+36Sw0d26VR5Qld5/MCDa699gr+tU6sgXk2i
aq8TZw7ggYNa25S2qe8jU5qBJ4nCsoVgLkuyhBtvF7prxXd0QMZHvfSLK52iw/asofVS0SwMJ7QP
vNcsVO2YkxRhLuqFM9EnT2rqVXRKwxW3snjCrce69cmMVqbK5tWMNX+7oGpV38lap+iEf/gu7Fn0
nb9ymEu1H4qpuRK9hGucM3k9F/60aQzM0tv5KZu6B7ftza055XsG8LALzVlXenTLI/rfYt6ZQRnD
E6PwiZtI96x8aLkdWk2+Wwwf2Uu0pVVNqCh79k6q/tNRQ3O/YuDcTemWKADj91EX3matRtPBqbPw
mtE8wQYsWW3xCvI6ePO7uNErz9fadD1V7Fvg0s1T3tgIbzqNuzRSTrIXSusbfGp88ZIm6MIiM2ru
HMaY3BGwPuKkopYaYv8NTj3q1pjdZC1sNAA9Q0ihKathqdd9uSuM0r2KURVsqHP1C9vx9ZUKLVBU
vpxtmtF+TIz3QZbvBviBeProxnhTzDmvTbP6Gg2OWlqzH+QLIRVa1fYAVPK186PbBHqlq8BypJ3K
heM7mDWZWvecUY7x2pTiAvZzZwUvr6Opex5KH8zG1fpV1+yl2yKWTZ1no+gpX/TVsDO1yNpjqaMO
vG6HQ9mJblV120p99TPLuikApR8ydtNljK8pavrAvwqcKuBMAUkrY0hWTmPeQtlYH0jjiyWDGMlP
QqVjkNHG1ykyT+S5zqLX+E/JiPjFnJBCTVPAuCtH5NsoxG4q1NBWOtqHAm0TrgtIsfr4wEg1L+pl
usGUN0dCazu3UdpV6zMMDv9joBF0C2F6AIzDJ9raxqpE9rmcTfsxSuqHtmixb6k/2/gOrMx5/lIO
9T2y8ODWCSjP2oY6VlXRrKA0PL8QJTZqRXXM6hq/DMZ8eJVIOUAyI9xHorKdUTq6M3IL2VMwpkNP
wbik6pehjvysp3679nXMIHzXSZfVYL03RfKRi+sVdmy9T3WzW5xjpJpyGfFXanh2NcW8Wof2KP3o
c0B0heAWP4sg0u8SSz0a2aivfJE2J0tpOF3p41NroaJCNXNqxJB6Q23Vm8gqv/YBmuUSd3/K7HvN
Lw+6HntBB1xjEWSlDruosWuoXzXUK2Mn+oAq9RbedliVM8It2x7kAmVotjYH92NbtQuhhQ7XAI/T
GeQuKqfnySrWoWWPa1sn5hzaJ6efjtJw9pCMDDADE7vy08DaGig7lhGiN7ttkys3MZEGW4X7KW7c
+8Ztqg8jbrJlYX+stfIpbnLkznXj3sJSbWorYPKBEu8xwymReyqv7iP5WOgjwH3fzuvZDQeWUEjO
B5azrBqKWYUx9Tu3s8ND6lvWqnCCESFrekhKGXhYnTzMeNbMfS14sG17kZ6JiqF0v3QhjtWDXq+K
wHiGKtAPGn0AWvkYpMFc7XQHF664FukySctxouQ+Bvs6hU+zpuRUkI4f+mmUtwodi1+38Qajp3uX
iH4BqSHvSm7+jgFa1cZo552VDTeR/2wnEY5fY79OGOWHL1FoU9L1MSVxSAOUk/OIzdF0q9VlvyDJ
wEikhZmHpfMoumIIo+3zzmx3hp6v2ViP6dic/bnMfecwbl2ULzI1zIfAJyAa4iy+SSg8eWVT3ISM
O2Rj8bImjz5XXJglg+ywJZ7c+46EY5X3dbTFLyz6RPOF9VvXy7KGsPDyWvibavo6uuEBOW9LzhCo
cJNqQJFw72B6vdVfz5h1emXJSJ2+XOdD+ZrnN2KYj5RMojX6qXrfxSgMirCNUZiN1lVhXY1FwrAu
jQDM0HqXB1N0KLCxxBrHYKHLEm2jpoWg0lTQPRWKYF246fBZ4oPBWbWmx5OtXYdWhkfCJHbWOK0a
4pVFPuTuPRHFsGoSCyUuxH7u1iDlQ5kUH3OjyTYlPZWFMWFYtZixidnFhoWNSCDuE3ui5WVCkeIC
9Z7qgzdCT4LSZyvV6C8d2jd7jNIPos4OkTtY2+js/dIQw+Soh7/UbrezURDkj8JBBO4/q25aymrW
PXZeudQFmr1ghArPlOXVZk0bZ5I7JE56xlg6iCreaOWNORWL3rXKfT0frL55xExoM1jkg1r/SAn3
IGZj3yuLPdIOH7S4ddboz+mQ4GAtFPONwbeYWzQPi9gMz3B3hYIClYu2Bmd2hgUdGncVQF17cVyj
9cur7NR/Q0XD/rqJ7/yB1x4apD4cMfxCIuJucdV6KXRkST0SLt+8H9zqPY1mxKd7PIrj4xBA4bR3
RozyefyMsTBrF5jPM8ZgXjnivklHorXpUApUIeeuq8Ds2SfmVIH+nncn4kKxTyDq6bJvWzfbkcwC
aj7SBsLQwAoIfZ0bP3rsk7pkJcud1dXI8HjzZPVOc/uNiB9YZJhgZk+oeItdNJmfAxleW5IpLUa6
cspP1qiLrWN+LGMcV/oavY68waNja/B0fmkQfj31WW5d+4G/k0CbXjszqHyIy3uI23tefyh8Ycfk
zvYDB7W4y8wxP3Imkg2k0QsMvjJj4RgJLwaXmtXc+6cuTMqvUWZT6J78o+02JD61zuhje3xMmwzu
syiWuh0vAdFdyuEOKk/NqDA8MELyb0irKxSo9q3Gq23R63iseFNVkL+IorwapiD84oCAL+MJW4nQ
b4MrdLpLf8b1K2OKAK5jlpyX4Yia1sZMYZUaxL54OrVekUXOIrb1WzwBh1MudeeETJDye4h2YdCE
558nMZhzPmxi2/SXbffYzI219TODZKXWkoMk2/hIuR8PuX5i4qMziP5DmpraVviae5+hLbWlC6UZ
Dg8o/2gRdYIaFIK029LsS+LisF3rsZXQX0F1nsSj7nh2Is0djWT9MOTa5MWdfzLDgSBRCMO+Qxeu
dlnRXBmkhujetXoJ0Y2Gm7HPHjxmuxtovR0rOv1r0w4/xTDO95k7xDssF+fbzCFjX4RKGZ+VPzkF
jxHyV1KvYVqpWjNeIgoQymqpmbURbq6Vhj8EvBqt3wGPB6PMh12Gt+U9Wk5rb2hTsQqsZGLLyINF
Yw/BdgJB9Gy/OWbjFCxrU9Q39mxNiIjMxqMTzhvD0eNrhme5B+zXkq2wxt3gV+JKKpvmlD2Xt5F2
FnTSYYsgsi20mXY09p9bXSiaVZLsxooVCXKVJ7uK/HudNNUnMSaoooChDr45BVemCqxVpMrudXIa
98Uoe1i7qU+J+VoJlAt9LK8qfGagiZDlLGptGm70QMSPozQiyzPERChgFML5AFOcs4MmKrmJTTRF
pC7lk1HM+sOUnZ0R0Oqn16ahZTeY8mWf3Zyxrjqc3GI2NXkTYX2EdIlgT2W27V8nuamZ+KpkyFdx
V2q2RaTdl3kyHOzGZZZPjax360NE6+uiUn7CAGPWR1RM5ExdZuw633cwco+e7bq1lzyP/XVsGk+2
yTigjDx/AQstX3Udzo2OVdpfUzbFa7TT+nxH1CH6cw10YN9Lz2JmHYlNSmEJm1KUsX3bYayCgYyn
czk+GZlmuBDgdMBwO8LcoRzuYfg+KNQzAoc5LzRzBCjAwJ03iwTtRVGOT4ghgqPJtKC11hkPYYi1
TxHW6ZNvtvuUuuSKy/8+wIRilY0Wckhcpye6sodMx60rLcneidfVrpsqP91lfVutbXzHNyrtm61l
zLfWiMEJJQ5xO8fN+47Zi9dEtNNtLdwY0aWW3PXkf+ve5q6cTas2lRvaxzSYDkley0Uvh3x3TseB
OGd54iGdVqEVaeNZABzcuGHiXqOkxanSnrwSuOGZu1h4vZ18IgMPv5kr9T3qHDu51mDrN8Df8TW8
LeI1g/cj/e+wMpYBY5+qfkqOYds2WzPq8pu6T7U7jfb1E/tAdT/kho+xQESRemrMINj0gwHAaelx
BnyvxeGXydUbB1YRIrZ03eRE7p54JDnydRz04V7WJvaSUqA2cTUbWzDMKmVUOVtNw7FN1xz/bhh8
+0okCdoapRSJsg+0w1sW3zSqfWsIh2M2z5Cz+ki8lqNtVkt2m7Ta4NQy7WKJUnqW+LCTNySEPPGQ
fYp8Iv0+D8Rem8PkPbPe2sdvFX3kAe1jhQhoN4Ru/dQGIZN2ZXPWyxTdtRr1Llxil1ksqQmogyZ1
ba1P+Mj5+GkcpJzmNfnSsXWy8mM3t+IapjaLvLRXvpfOmXrC0LReykHTbvwRVwc96MuPWFU6RxJq
2p+idtsrbMWmGvcgvNMWZdbOL7VMqMdj4YXiZx6dwwBXeFNhX7dwuyhfVaKk9tP64lhFQX4IQW6o
N2GKR5czPfYhLq16Y8ph4Qb58JIlsb8WWSserXQoPyZT4Nz6OIxuE1EaV9gb4qyFR2t/7WJHHi7m
OqM0Oxs+JintXLSPbptkm5SmKHZZMea+GXQjET2zl141jRSC4Csl8gzL66mTw8uECBErhymHhe7s
O2Ys0jbRrPKGJrUEjdSex6hOsdEtTIUN52ReV5Oo14FZ0K02ZvxnkA7bSNpTUHhRDvmyivXiJstE
cizBodncjeQZ/9rci5rMuS0bYeyGxjKeRaUHMAtCrSZpzOtR5eJa5WzCkzuWH7WMf+rxKOnutN31
1Dro9rKyfWy7yL9qCnU6m6g8mkyQvMp0TK6Q5+lY/XUqdW7T0IhwPOnyjUJ/GS4o5BU7FF0oAvw8
W0cluAXQekkhmFT/sUMGC8Vc4bW5iDoZHAdTZl6dafI+a9huN1i7zLA/PXfZMdJ5o6KzR3IDFt/H
g/3SIot1F53dlh/LyQ+KG4zaWrXQbESOOtT3rc+EBEGZP8evZSqdFXy88xlS2MDmk5SBKX25C1SR
9dYafY66ziHIHuVIhXwZNHDvmmzFrgux1NUMnAxDKaatZVEdYV8nnDfdAalQEOu/Q5P/t/vZx+il
xhv6a3vJ2P2A5f0/BOKdObW/6XqHUf5jy5tf/6Plbcp3NokWWJ1u2BQD/9Xyts13CkbEVHSddUk3
nE7aHy1vxY+Ui7sOgSwG4rS//mx5O++EcoVN8xxw79/odv/Y7NY4rC1tk3bAj/07EPkMxM8NbnSm
wq/NPLG3xYAy6rvv/xfdyZ8d/dy1/A4NFrby65HRYje+y6M5yCBa13GdvsW7nnO/aLQm1AszvxfO
CbQ58ewuRhbiy/ItDCxHv2j/B8DfloKCO5U+a7fVomPV1W8aY8jBzxfsuwsTZl2DyG1UJ9W4j6Zy
Hi0T9PBtF/1iEIgT11ZUSUOeMhL2EYejIRHLtx36ot2OVBbBeWzKk6brD8qnW5bgS/uLg4u/dMTn
opy7vt9dlKFg3LPda/I0lUXyRAiE1ltv80/IxLG0RkS2SovCXGd5Y2ARhHMldfz4LRg4n30+p+8+
u04CS1TKlideZCh2Y7Wde+PlTVftskeOQU/Z+CM3RI3DKXDdAVthssi3HfxiAetIV0tLDeap1fNk
Gc30VVK8Y9528Iv1a2vG5Ix4+p0QOr2U1UzEYb6+7dAXi7cVNfwOA8BOc8CdnNVwLAfDeNub4RLd
QY9IlOLjX9+iFF8X+EBsDScOvbed+sXi1a0uDWQbGyeAjq0Ygtuwdt54wS/WbjkVOEaWTkZ4RE49
+pjtoSp2fwGLnE/wT3ziXy/7M1X1/UOOGSzNZhNScBpSF+dsVTQ3HRMVfjUO8GfHv1jAyqxwRejr
8CaeWqY0RHgXm035+PdX/YL5+fPsL5aohg+Tsok06Y9TYUoqdxmhZN4w29ugiKXl/XogDX+1XLp+
fUxe6SL6W01xNt6DMVLD0kpDve0+/Y+RPyRh6YiF8MkX8QZnKmcLrJH9Atv6yWW8HPjT9RPWU3ZY
ndrUv/d78j4aT2/cNC9RsMBAlR63pXNiSh0a5ap8ph/8loGE0FgXaxpRA3LC0kE5zgv2UeLMG42J
/4v7/7OrcrEfd3MklJaN5SmPLOpQcsbIPka+777xlp4/97sdAPdDiRFOVp7spIv2EM+hh3m4+fD3
T+/Pzv5iYSNCtUrce4sT1qlY7LhyOKrRnD78/dHP1+AvFvYlBocpcz87bmOf8IoB/g5MgO8uV3tF
13X59x/xsy9wsbZNv+rDs30gkIVa4dJP8cN86629WNkY4/gQ8NI6dfjKbej7nL1Xcu1tr+vLST5k
pEaFDb9xqmzjaPnpVRUkn950US5n+OQW5kazHhcnI8YqDQK/m55qv6ze9r6WF9svFmlpVVfibIXu
7xztYWzt1d+f+E8eGHmxUn2J/Q3aFfsUIVNe+cxCe2/0aei5USce//4jjPOx/uKhvNT2WBq+aaCm
zimznXmRuqLZ45V/T4uWwTB42FjLUQvy91ExeP1cfWU6M7NGRzU/ToBwVL5KsWkDJhIv4j639oKC
OBsi5b0wHJPboGmekboi/y+ZcVtEOwcm3ROlbHc1Ixzc/RgZ7//+i/zkyTcuEEeZlHiCU/bFpIQU
ScWptf5fnJ1Zc9yqFoV/kaoQGkCvPdmOE3XiONN5UZ0kJxoQQkgCDb/+rs5TwnW7q3h2FY0Rm2Gz
9vpqhbSGV+tuBSthqJWHU2B3nuiGJ0GBR/SOQHjj17qz7KDew/aabvRcm+YHakXewiv4g1/TzmEC
NjVtVQY6O7Ng/gKI2/tt6376Ne2sNW3XyW7dVHY28AvGo0J/Rn7E8056kaP/uc5D8xRXDWyrz2XC
HtNHOLPc2P0uJ+4X5rtbqVoYTvmERs8wpiR50qOYqCTAJeD70uM0K/0vcmrJngdhfH59nK5EsVu7
Gk2QdcM5gJ3jKFzfIlMt3kC0B8XCRRLz+k9cmfxuDSuHD2cCRVt2VgirXZ+175ht/e5cbg1rCOND
UaHA95wiaf68KK2/mmLwArhFKHJxvjPYWw2NsCdyod9oqv6B+caNL31t3C+D9cdRAaYdeKItJT9D
j1DnEPugcg+vu48FN/bGphVe+w0nckXVw51gi/jZCjzviRW+X31KA/j+1ePz1CXqAxyhLOTeBjSl
KuxRAg8h/nGG5SooGX34Xq4TSvIVS4/AVXU//KaDE/QJiQIJu47kvEQVzKBjcRem/Re/tp2oF3WK
gsiowQkjE/ec4LWrb2C+59e4E/VdBMl+wUYcMcRAT7GC01hlsxvHrytBQp07+IbHlnUmqC2c4CC5
6weSfbG8LPwW2t/FHX/ONjz0BbSo6dkg+XJEuh86IkU2v4H5vXv/0TrAL5TZsEjPpWinB1kNn9oM
Psdeo06dGERxRSwGlJKco8I+pRLWovWQ+E2X3+U7f3ScwCERFrLITSz98thkQF80+v71bv+uI3hh
KadO8FkLYypUvafnJp5bSMTm8nuMh/+PsJIc8BaOh3jY42XTE1DceHlUNfuoNvYDrzPyGfW/cPZO
F7jg6FWnnl/JiTsuzAIn0KQ9U0J7CBAiCumdjb1sNKAGcUKPlGsGtXYrUWmY3mHT/Y4yldCz607k
hdAahlmctucS7janeRzwqE6g33/9U10JvdA5nMHKtAoCztpzHbD0HecDTJLi0W+DCp24BihgTEEL
as94IvuYsfSuKuXBr9/O0R7vZwnMi9E0DsJvIQJOUWng17JztBcooQAcJWzPGWm/Q20Ba0/hF86/
96o/Qg6Gm3KcQM08BwH53g1wQhkmyCv8+n35wn80Dn/ghgxgXJyXuIMmsKHj3cx17DlPnIge4RPQ
RhEvzgXwlNDUKb1v13D17LsTnsyk4RqC/gawIsvulxYikLLht14iLnPihdUodKOzSgmF9pufi5j8
t3VyQsme6p6g6lGoIYBbNXQTm1/u6Xdu/o+vMPeQiy+M8TP8eMtHdTHtWaJ29GvdrVLLuAraNpHi
3FGc54Niekad/Y1F+zJPXhgl4gSrKQmeckckKEwD4BCc4KoTqHrWbykgTrxW1ggBLoY4B0U73klq
T5DpkBvDcuUDEydkNzwhp00PiRVq+xp4X6yteZeYGWpyBWtPuYv6i6A07avGLxqIsy+TZJtNVEA4
G6S4FO4MDadDtfZ02nvFMnFiOYNqpo9j2pwnE8AFINYnqMu9HIHgjOeEMoBsYo5hWHBeUSe2S6Zq
3dsJJu6vd/3aKxRxYplU4PJEKkDSBdCfYw15wB7iFHEnR1KcZDVOb1BvA7UO6v13asji/yYV4tT3
+q9fm8ROqA8FtGgFDG/PEnozbsR9lA0+LG4Mm7MPC41KJrj5i3MJPbypIN8pxi8+vUZh5t9LtwxQ
XDaH43aOWx0AT0v3xki/lTvMnLiutmCJQwncAVQxxS4Bowju8TcC7+XhDjMnqmE8H9I5AnyFkvhn
0OL2BrWb35UjzJyoht+J7bGXLWcGFCRUmWUOp1zuFWFw5/l7yLHgdxDMNg3evis5gCLJkm/Tmsye
zTsBDCPAEY5LaY2TTwUrGCjrULPqN1mc8O03VKCUPK7B2lkJDLujiOA0XQeezTvhyzbbtiu47Wdo
SCEsnaCpX5TfAxfoeH+Pejg0oio3spx7kXye4I68h5GqX2IKJkN/N95D+YcbfLmct5GPR7rOELJD
znDwGnbuxGgFUeCMevDw3LIm/rkwMex0a7lXjhT1+H/3HR5Aa6xHsp1Bdv0PqqVztt5at15OhITc
jdEYSEPS2+lcrWP9vhhmqEOTuv0E07bx2W9snEjN2hRkTaanM0tF8yHQJcClUsZf/Fp3QnVYwJ1c
EzaeK9wU76HG4+9wq+Q3lrBLH///2IMS/L9HHnb+Y4Di0vHM4DPzL4wzIEKHUv4Osj1zB/sZFCi9
/m9cxvulH3LiFl4GSTENCm40UEPvRA+lL5MKxuh8LZ+mWMNgU0Ead2MbvnT/pV9zwhiuHH2p15Hn
VCenOgtg2O930Qi5E8RRk6ZbBdPQMzEruHGcL8C0W3pjmK513IniRswcwKmQ50Lptyr8iCoLr4sd
NF9/f+lUxdAa6JhDT2xQ3z4vdxtUxH7ddnVgcF8CBKMCERIQxBJIbwb/rrUY/BZl5sQwConbBH4B
QR6AhaTgoYIs5eH1aXllvF0RWBdlSwCnqiBv4H5It+A9PIn9NkFXAQY3iHJRyHjmqVwgHw4hv208
B+Ty3/xxzQo4ZeDgbGjaoIoBtZ87K83Rb0ScQIXiE4YVFUE5FkwiwGVjgLVLdWsZuDbeTmCipK1O
B5EEea0yuWtEEEIRu3glGEJXAZaYiwPfaIIcSmY45Ch9V8QoNfcbFycyLarkS7XGQa6C+VOAyvhS
lDceBK4MiqvwomVTwEManxMVq0cSJw+N7L559Tp1dtbUjGHacfR67FDXPH0eSes3HhcjpT/noA1N
lgAuEeQo0wCLaTj1EI77ddrZUC2Hq/xWIHLoFH+wqN/lDBXdfm072ykMpIWxI7q9lPrdYpZj26e/
/Jp2orKk0bTCVz3A4x0v9zIx35Ix9Fu9UycqkwzWZbZD2yCQcSA2l/cxNZ/8+u3G5ALD4HnE9IOk
7slI0IRLC2sAv8ad7RJg8FIAA4cJCGCOScg96vk8Z6ATkWkBvDUQC1m+2JWiAh13DRPb7eTVcVej
JWSktalnTBS13KNk+4Cctl/HXYUWLDmjGqUjRQ63nuMApQpUPV7X9NDVZ2EHo2OSodeV7XKcH+DF
c+OkeGWRctVZs5hLM8AZJV8bkJ0vu3CMGkm/WZI4USntiGV7ZFke6/VTOMQwyd7gJuH3JZ241GWM
sj/ZaLgYmmAXmugTMN+3hE2XHr5w0kycwMymsqvKcBvOYlOfaxR6nFa2PcF+Ljj69d6JznGYRpjX
gForejjJ12BaoowW5yu/1p3wTPoQJ5M4heYOBFYYHqKMGUkez8adAE2A7dpszfpzw02070p4P67t
7LdpuroslEBBABdtF86MAZQoG/hDzMmtB5Yr9yJXmtUSGs2gf+tz2ADLk4DutYc/pblHVXACLBQj
5MbkvDJ/XJEWvBMW5DphN8MiYXEiQib3OMG84DlNU8TY61/52o84G2ph220ldu3P4wg6fbwx9sjr
5nsHP9YbJ9LLeeKFMHDVWhJQPzwbJZDaxPEI11XUpB+2Mm7ypt/CJz20wUFnCT8tHZgfftPL1T6h
YtuidDi47InRM57yaqAEhx+vj9iV1c4176/Byp05aoTPsCKi90an4jShptlvN4+dmGZNEqDcs8Ct
A94nqMDeHnSz+j2zhbET0j2SS7hqlxclf1W96+OCPG1hs3m9ZIB6+Pexj6ZlAVTfZpHsaJ5jO38D
ukbemKZXBt2VQJXQlsuINiMkf+K9bkq4m8EEwuuDumKnuUOxYieH8ZwQjbJK0aNmffvHr23nKDwN
dI4Bex3PpDQ/CkLfh23r2bQTucYgj2EpTGNG0HnfxlTrAxRg5kaa5Mq64Iqc1GizpAq4PYPUdal9
h03UsSYWtlB2wsOR3+g426/qQ5SzXhLZMAQC+7qLH8EiffJrO/p7NobhBVm/6vVMQgarHPbNpOan
X9NOjAbYURKYhfB8AUF2N5rwbTpG5ODXuBOjoJVVaQhTY7yyr7Dk7sQTSnw8p4wToRPkqxak0hnq
E/NebMU/bKK937d0xayLNqxsliDLBw2n/JCOH2B045mLcXVQU72Z2vQyy6saEwW2i6C/ZG3k2XUn
SHFYANl7gFvjlvK3hK9vi2Z49vqa/yeCKi1K8aNAnYEborsYENwImU6/RdEVQWlbBCngdsO5SrJv
cPop9wp5PL9LjquCiuCIEW7p1kFhpd/XyJU21a3QvHKCckVQCl9ThA12UDKn//VdWO7hAPgNpn3p
vWK++VLqRGmSLQlAmAF+heHlowHiiaHq3G+bdnVNXZjOqEkpmnPawcc5A8PLStndODFdlr8XTkzU
CdMGVhDQTfV4gmNgd9cBHFrhR+8nZwhdYZMco6qZUfp/phVD9SPeuve/84ReE95VNkmlQBhVU40H
+uwZFtXVjhM/CUkYOnHaJ3Cr55TU5wXO0VtS/NgCuJj69dvZTVGeAxSQ5fWZdtWHOml+gYXn+dDs
qpsoAPFiYLY+j4Vh77J66r7FFVx0/Hp+mUV/ZHwzWcuAxBiVtAmeiJx/gilsPUfF2UTZCIBpVKv6
4oMWYKcjAKq1dew3zy8UmD97PkY9qogiUp1bTr7wJP4MJonyWxtdaRO8YBmqz3V5Fivk5fAhuY91
UXo27gQoGVH0bsdLRWxQF3u+lPA1Udlnr+/pSpmg3aNNl6DnpIaHBYc1w65Z4KHk17qT9W23qQKu
0RZ5BtLnfgCI57iI1TOf4oqZmAzUCvg08m5N9g/l5o0O5Xu/jjsBGpRwelWNQh6oTu8AYX+Gi6/n
OdRVLVmbrrYfa54HTUKOzTKVBzV0jeeQOwEax7UU4aoY0mPZF+TgDr1NP/kNSvR3BPVmrHQBLEku
5Kxgr7IGO6AIPUfcCU9oBrIYDmNFrrpgvM9AFwzW1vMZljjH3D7uIN6CdV8es4X/szRr+mu5gBf8
Fi5Xk6R6EsJppYlzoIj4aTBxeDQi++Uz6sRVJRXVCEDztEQ53mQ/sbV/3HrrdUInriaJbij6S+eU
5uUAhI/aA3/nd0AnriTJjKQJIAKbc1g0dUcbwj/LVPLkNyROdG6bKAgsOec8njm8jy4bUeSVzYNT
yd9zXGcNHMvLcM6TlWTnYYuIPoHYyfxUfyRzwnPVnMOlM57yehMCbzM1oFbT+NlvXJwARRUVaTcd
TXkUAGQKyNV/2Uo8p6ETn1oUwNrA7y8HxPS4AAu1YwLu0H4dd+JTNxYwxyic8llO95sJnoBffvJr
2tk9E8hg+gW55BwkBOCPN7ClIFF69mr8/9RIEY+XIWunvOy6Uyqzr1kV+D0+EleLVI8AFaBecMxT
kNz3NG1PKOP2O2oRV42UgQu3iZKN+RTFn4QR75mVfosKd4JTzMPQS1WMedLEcHYOuQkfgIBLvA6g
AJz9HaAgQ8B1U/FL89VPSZBsTefMb/Mkrgppg/pztnUy5qBnL/uEt2yvt/Gj32RxojPkVjRIKKoc
iHe65waEdDqUniHEnfiMk3FD/DcqLwDtWOF7j5Sp18mZuEqjhlfTAHC0glaCHnrzL8Xt1m9InOAE
8VoCEoGWx3QpT7Jc+kPJIr/GXaERTKhiPTVLly9ZId9KMdNmb0RbyaNX512tkclAh7Ab7XKaroUG
EDEe1zuUe29+wh2SOpGk29JmBHi9HGzsN8lmokOVzZ6j43rLrCSY5paGfU62An7cjfgQlNnP10fm
Eov/n1IgqbPJBXOzDrg6o22QLt8UUxT9uBzB1C6aledG6mqxgIwhKyD3XT6N1aM1Y95xcqMe+dLN
F7rvarHwljPCCznp8jYCMmAXQr7KdnDtUH4LgSvIgoNx1AaJlrkFBVPto2HpfoWERX47nmvKFW6m
QIXQrHK4fKrPQQ9reRtI6ndAYs4qFkkwJGGcLXPQ6p9Fon+aWH95fdpcG3dnCdt0y/q1bwycF//p
YI0dx8xvT3IFWduYFEEr0DJY9ftk2+CRTXZ+nXaWMLwjmniYa5NbMmjgbsi+KQe/iwVxBVlNysqZ
gumTg7ne/UDCaPuEW9KzV89dSRYvUeVPwQTJaw57gjJaP6Zb4iXSIK4oK514WfMi7vJ+hZ27hFn3
PR4tbhUaXZkorgipjzYu6nge8nBIe7Bn7Ky2c63G5JYRzbUfcGZiIVGZOg7bkPMySPpdj2E6rkEc
/fQbeee4u0aQUc/l3OdbWp5b23eHRTZ+ejiSOhNSwT6Ts2Yb86bW7+gSnOui8dI1EleKxGUiTbNJ
nL1s8wz+0l2SDH7LiitFSlq14XVRYBlvYL+Li+OzTIPvXsPtapFA97Ma8Fid2ziAtmSLHpZR+z3n
EFeOtJlyq8Au07nQ0fKBF3TbAyBf3jh6sZe3IlePxJJtghtH0OfAv2XqkCnL/1F1BbaVnJjZJ4Np
941MYdDqN1SXgPgjvbuNiy5qLXUeLIDiFi0eq44cwtjh8Hr7V9x0sP///QNDY8FpK8Yh7wUz7N8N
5rj2HZ+K7iverrn5JMGFARx7Bg2xu4P/HQxf4DxC+s8zYXQAuEdFcl+Hwdi/QZa76XZIzsGOeOqB
bIvmMNr2U9agtJELGzwDuFa2uRnI8zIO4NbOxcpgmR5MkbmzHZgBZV0udKeDiHkB7SPiWlgZytTa
L7TPK9bfQdP9dVhu3e6vlPSRxFk2gOSxoC/0Ou+02dI3S6YI/5YEML3eczUNFx+xdfyk1Crmh950
uj0NxQgXuVmNkd+ZN3IWl7EUSzRCl52LYjghafkdZaR+e7T7pFuqitsR7pX5JsYDz9QprOYbd8Yr
59HE6XXDu7kY+KZzVg8mO07cLOQwbXWjcZ0JuJ8OCDjlv+c2UYD9jCLSOVjGhyzsGCjCsPd7PXIu
EfjCodQVgumASsMF1TmIWuYpbJk+VqYc/b6rq/6iaQg3QjHpHEwV/dxJGZ3qwAi/g51r05UCmt3C
Dm3MoxUm3AS9TlG67rdkuYqvGRbu9WQwbzQeYXdRwd+0LPCbk66ya7Og09FpxaC3BcprMgtAfTv6
eRiCAurMlzQxle4WjQxPAn5amTywQN0Y8itT3lV2mWKStrCFzoutTfYEaakHIKLhSieX4saM/P3K
+tKUdNYj2rYxgW8cNguZyX9FN/6ysujuscSj6Hcrl2+wXC0eg6BQh2UBqHIU0twb+PCfQn0hqkW2
Okxtj5fPpWEjeCPgPlWoqB92If50YyCuxE3kdLLL+igEoVHnZSV+DW1r93WxLHd+QeksLCmbpCAR
4AU2qj9ska4OiYW83KtxV4UmWRbAdB0xyZb2P/jVP/Taz+kHtPO/Z14UWblVazvkoFMfTSoeYcTw
06/X7O+mWQA/5WRUOqeK67eYeNm9GeV0Y85d+5pOSiTdQoXcIlbysZnfEfYehHO/S78rQRNLqgpl
Mp1nOnxmpkrPAWvWj36Dcvl3/jhWodhzgY63RAYtAksUrJhuD3eNZ7/GnWWkMBUqqAWSaBkYmHte
gY5qOILo9dYv3+2FII+cq1CVLNMQlOWQE4NELtCx9l2zku7NCCjvGwlK9mecrMyNqoErq5arvCpL
+CypZMDFqA2KvTJS7NZAQccLqbDfduHaUGlwmNmw9H0eh8Eb3EvvhmHzux658quokl2fERyOamaT
zwI5hw9L2k9+a42rv4oTVVWixWeGV2+wVzUy31Z55jJd/VU7iHoB8FrntQUTsJ1hecxK7nf/chVY
SJPGdVVIhes6+wnEcLNbeln7nVxc4dWsymIlAvevdAgWQG3hqQsCp+d9yFVeoaonAOrMqJwE9eMF
o42yT1zXXw+tK4uZq7zaiGzNPOJBQG3V1x6H6bG1fquZK7sqcCbKgARs81QH05tRZeBHxoPfPHdV
V2VfLDPq91TOo/gAm+8voms/ew2JK7raKvACY46mU8jFDnVb/lDAM95Yyq6Md+hsHnqedGFEj8sL
gT3pkpb/jBv1PJ+7sqsIXvjBXGPpUtMo7mkcvOeFmk9+w3L5j/7YP8ZhLjIZkS63hilgZEh9qGvu
+Tmd/aMEzaYHdBd5wGD6zqrysdPsxsXr2og7m4dMGtuCMd7nWVVFQNSXETDBPXvjNyrO0a4OZpjX
LXiACQX2iLoMHjrd39iJrvXcOdmtYNdFTTl3edAfWqBqUGAfFX7z0NVcxYrzkafYJ8DM+dFWI9CC
sMnxGhPXPmqsBtjuZEgtNtG6gw/Pfig9z6Ou3Kqq7ZYGCZZxM7LPCd1tY/HVr9NOYAooIG3YWUyT
lGY7vWdxmnmOx+Wk8UfkgNtbdn1dtznnaLOfCvBt4xu3wyunFdceik9U0LJLMUfKDCcV1pjl12Aa
vZunbX72GxonODOwQkELYC2EaFN7DHhzXpJZ++2drkcU8ujZnGVxm3fImAVxAR7e/MWv305sDtXW
rZRgb2NcvInWGMhx/fP1pq8NuxOaw1Si2BGIibzHbfNhiju9b5DWeYjZ5tN5MO+cRE6jiFn0XODA
Mo/0CABq/K7pey+bFrTuXL7UOhCJPLHKB25OoI1WUI60tc+Ki8Yvx/g/5nu4BiHyaGWfd2VyB1Zt
V3nV3aJlJ0gNGJ1lIOoL/rwlu7YbP06i9llt0bYTpaZLE4uKmT4P9Gp2XDOQqAOf7Q1tX1b4P0ak
nmwThwNWRORwvsKY6F09DJ9fn4kvbhJo2gnOUVDGkrXtc96az2blT8lQf/drmv7d68jyaFKDujwR
TcDrZT0y3cmNEblMtP+70qHbTmxGvZiF7GWf65D0+zSqoicWkuaOp1N24Ekxw6CeBAD26lvPGL+T
uC/9pBOziQWic2Rc5a2e1q8rSN9iV8miOZqM1Y+yBn6E23DY9cG0tbtBZuIp2wiOr4qB5z3w5Snt
JrNHNsGcRVjIO9E26zOR8XQoa/YUgca1V6IH6hxsx7cT6tl3QvTmMIw9v6v7AXSTeeYnQHP/USPA
yGRdSOmzxdCMO7PAkiIJ12mVeZKmH9os+xGCgOg1C1x9GU9MGQek6/OITHKHGiSwVbvB66yAjjsL
UdbX5VCnmGPTiMsk2di2A6Tb57qKxp2FyGaQTxO4uudpWcJKFDSqNRHi4DcuzlrUNl1JCya6fF3D
I1tpsysy5qW3R8+dxUgpCxxGvbR5KOFUGST8fRbV//l13FmMWBPOqJ9MZF6G+muaAINNey9zZfTb
WTK4HqTgHEHDmvJHGcjvdOZHv247Kwa4lTorDIakCZPpJNhxQerh5Ne2szTUbAoLO7ISTlNUgUKv
2rehzcYbwXllrXNFYGA6W+BHlMwbGrZ367y29xvEAj3ARHvB4uAQxF2ym23iZdxHM1cVFqhOVBbv
Hflgqa2OxqBQLpEh1iKv4XJ1T6Zisid912FJoHcRQ41M0CsvWSg678TVurJ0KiSugrauPwXxPB50
tXlhu9C4E1dr0XcUzshNHpMhAtoK4OE68aruQeNOYG0bnhoIrUSukXLeFYK2sOdmH/zG3Fnh0zga
plYiK6EC/bUG03qXTZ1XVgI9d8IWpsdBBD21yqvGFrjWvwWqdbkxWS6L7Qvbrqt7GiHWAPi97CCO
K9b4QEZT71FNoPd6SOlDDHzjoyo7z+OQCx+sQZxaY9TJQJZff6zkQ5ySL14fwNVBCTx3Q745yXyd
O2Bgu3QGWEc+vd74ZXK/MEiuDgpYgm6VjELRtmanKssOScPvSNZ+C7dbqoDfWaCXfsPZDbsaJN1p
i/EPTJwsxzmtf3ZJV78PWhReBrYKn7e5TB/LkE/xTlgi3gI8jt1emki/jwuGnvThXIP8XlTLDzuG
7S3d8NWuOTEP64TQEKjM8jrcRr2zPXbTtiz6t3UHz5G9jKQipwEc9/se95S7ig3R2xhIxa/dWkdv
mBbrfTC31TvFWHqA8EvvX/8sl8h9acic5SKjZS2tDmS+sTU5tATIYjF6pV5BqXWWi4lsadzE2IdN
lGWnZKbtfs2gxfTrurNewOUzDSaQhOGjZivUMQEWXcC2zbN1Z8HQA00j0/VIO4So8p620uyW0fPe
kTo7PUi/0QRlPa6+ZGZgLesU/qrRjeXo2id1tvquqMyaMiLBmJ/3qiW/Chp4AUBo5mrTwqxBUkAi
K9CODFOli5sdXNtu3Jguc+6Fueiq04jthyBVHd5eSuA3t4ou+26N+OPSSi/5C/rvrBBtB+u9WKUi
lxPnh2GSb+xa35oy1/rvxDi8uAAbXKxE5R6fHzicQ0G4DyMEs2Z+VxVXqVbXEY7gqpG5TpPxUzvX
76Ng6j57BVTihKuAZRPY52kL8D344nLKPpcTlCR+jTvROuMlfOm6GT2/VE4w9bblwXu/pp1QrZbY
DryQwTtkwdNdQ5pix/j4/fXGr2zukTModOtmOoadyNtp6eJ92QtySsOo+aw0TEIMS9e3i4na4+u/
diV23ZewQo6sopaKvFiN3GsyPI8t8xsm9yFsVVXDG1T15Wat1B4bX7afkslzZXDfwqAY6NK1mRFZ
MYk+zhkyCrBLv0X/uvIVXFFeK5ED6gaEFkhvx6IdHvnY3auIH2vUytG08juCuhK2tR+yhBSIAFEW
X7Mye5t1k5diGEQJJ90JsDOdgei6tG3/i0l1X2bJ8+uz5srZylWtWYsn6wRKRCT2NFL7VdR3DwQS
oLtOmOxLGXPx8fUfuvT1hRXaFbB18I4GiDxr86xMQM9pU5BRQGvv7qaNzA/dqhdo8xc17HhBBDRA
o71ViPLbQOCFn3afQ7Ok6yps9xJZ9N6+W+aVPLEphoGRLbvTNAVmB/lHtq+7Gj6wSRnsadfUz2nH
6rdyC7yeCPER3SWeYHWZU3zELqRf61b8I3ovm0g07ZzEls7AK1PgmSBm8iQkanm7If739e92ZVlx
FXbZSrVSG9regvVDE03Rrp+VF4YCHXdWdh1uSw3QHNYVph6LMmkOvE6nk1/PnbUdKWtl8W6HI6SR
ZC/M9C+efz1zOa53GodL3iAH3uR1RaGYTO20i+r+xmnm2pg7xzATNpVQZSnw4Lv+mMNh2m+z8Oy5
q1qDepsG4YT1sJnoyU7B96m2Xu7eNHNla0lV6Tld8D0zlG7CwUt9HcvE7wnCJURaq+a+1avIy4VE
p6JIkz3cXOs7r8niMiKDjIYRa7BGrOMQfASx4I0K7XZj7bvyPV3pWr+E6ypjbHDxulX3KuPtA1L8
t16rr5wdIyeI2kxVGleAJq9IXB+TFA7LYZqUx1Uoz1yxqzGLGCs3y4zIIw2Py6V9Qn2J3/riyj/7
pDMjX2yNt47+eRnE99Uov6c2VwvfNnKmeh5EPi6sOtpRmT2qeErP85azKc9drUA1woyZF5Pu6jh7
0xLUQnhNR1dnB3ZsBroIrr80Vo8ZIxXmeuJlQIRSZucmQ5DNpT14T3lSQyWQkWZHDPZ+v5472xwQ
f8rqBYkUiBCSt5y22Y6o4JYM7spxxdXY6VBo3IgSASfncBfY5MtUjAcyyE9N1sye/8Eliv94j1yr
uEXSPxb5hqrYoYZlvqi/+Q2OE6ooqKGT7jPEUdN9gm9xt7ctuVW6c2WVcYV2SQItfFZOOEbrpt9B
l7zsimLyTGu7wq+wjYNlNFBSyzA+gJ/6aaWx36iEzpSxsaJ05Fge081+HfVJzsxvcXE1X3OIhLOE
EWHeLPqhnZtn0c636kqvHGh/Mz3/mCbDwsfJ0qGB97wc5KPuGftURl11UF0HY1LSVPCCSqMx2bGu
ot8XYwq/m3zozCIeBQsdm0XCKT2GlHiE0TM4mr+8pqjrwqXjCLZkWYQpmlJ2h3xHfDcpa/xiy/Xh
kjprwahZRB4E9N4ORbezme/JxmUKphM0IbEhODYJGz0LquIDHa29cUK4ss26orC0HJIkSStcwvSS
3afVWr7PoLb+NbZYlPZeg++Kw3g8LsQoi/9gaMddZ1pk+LrFb+xdeRgo2PEQDzgP90n1nyx4PsN4
0bPjbgjPeKiuh1HgvRfPm0t/14jUyxycZv9nx6X4lg61kflQBv2RpvQUsthzF3clYrPdelpLnBEG
fqFr0/K97ja/84cLEGTGtvNcIpTmZICrDcwQmn+1gdTBb7LQv/cpFa/1EDe4ulNUau7H1GRq11BW
+s6X8O/2k3QNRxn3Mq/T+COp5xaX9szLwRkf1bniMOyyta6RGyv7UOxjGnS7pNS3HpVfjlX+f/qw
lhttLic/Ct+Mh2qbtvtASLpPBA1OPqPPXZFYNNGkWdupzUlc6d0E1BAJb6EwrnXfOaCVFCJfvAQK
5PiHttsBXz8ctVi6D3XV2xva3Etb/58U4a5arCJFCxn+gFQ/2foj38S8N11ocFjDBJoZ+2pK7cUk
odxVjyXrDJZ1BLF7VhJ2XisuH3gd+11OuKsfG+BK27YSV3Hb9neq+TcdFq8jPnflY3YTQZXOSQMT
psQcbRwmd4EuPvlNICd8o2FOQFPBta2YmNqntOSHJVx8qvUx4k7sopRg1nLB2lBQKveETd0hiMxX
v547sdvJtc14sTX5Eqc/ZL/OcO3KvLhmlLuKKqKnSch0QmIFheT3bVxMb+K280qscFdQNUAeHXfA
uef9WMw7O2Xfq2j0+56ungpCJz5TRprc8Cl7WMA4OKykWvyWG9e0q2kHxoYEMmOaLE+azs0R5Cq/
51DuCqrYQLaBE1xLYL5UvqnSQb4fq2z07Lp7nwKxqh8JHs7mUf3kdHlU/BYe4XK8eGERc5V9ZlYp
aaIG01zTbcJTa4aX8C0EmQ1o6fG+U2F648z9+yXxpZ9ywrXelo0EKRRWa9u2u7Qui51ghN/bcTIP
yQCT86lc/ov6bJT7uA3inSRs3KFae7yXwAO9HRhNT0BJ0btiaPg+TEj1PkpNfFgNMR8ymCTBlqII
72Hjn57URJpTYXAv2icjrMgPdN3mY1kU0WnO+vbYZbYgu1pP8T0zM8qfJ7hoH+Nt/VQFnTwNzaLi
U7ioftnj+bzQO7PMcAX8H2dn0iQ3ynXhP/QpQiBAaCtl1uSiXG5PbW8U7m4bDWiekH79d+pd2bjS
GcHGC4cDk4jhcnnuOdr09ENdUrjD2jlo1hMIz0DR/ICmHwwVzmH4UjtVQuzvtpkrmB5vxRHLVBbc
3JeiJy28kwaR/80W0ryH7w4eOAjyn58knfZnVMPS+1gi0AnDuH+G5Gt75ah6/WIrXXmz4hDd3tQ4
aiHe8ETpcWrH9kqIduGklc5WtkHnRQRkxPPHWk43AkV7sJoz8ZkHq7732i1dwI1G02jrEnOUygMV
H0P4uevna/zQhaH5DWaLWRXjSyHujuMkO2zUneut6X2K1Kh0UbZmgKDFgKvmUwM13PRjyKhXqQpa
flnQP12eV3lAM2VHQnGq9+iu6XZYiWF2et1GpAuywWFcdvBARQZnndpMQgDyvMmp84sKXJJNj2vV
R30PTI52bRYt/O2ECnOvS5p01bt4EMcVkqwI/QJ9J5K2yJBv8YvopUuyEWqQm2s6VMPv001UrY8A
ePwga+mSbOEKZp0DIH7a9Q5jzyDUH5NVsw9/XkT/y228sv266Broao6nSbxul0zHbyLExd/xDB2d
LFi89Njz8FPdTHs292F3G2EzvGm3MCqygezivmo3W+Jf4l/5TTD33YqboAqFbErg7131yHL6zzTW
65UN48Kh5rJ0guTRylA9/NQEAUzIqdwptFHx4nQa5penUzrAAM1vurlonYyaTeB6UT3JIn/sePEs
bUg823ZuMUlkNvpiivC06aNGsNXgetq13G8VutqLLfI8IS5gFepoJpuiYI+BKbJeb03S1V4sertw
HcclhHyiEHLxGidfw/ziIRdtK4ttm02M3alLOpLlbYxT1G7X7lqXVoqrvRbDLyox44AUOdun92Vl
+e0OlOgMEnmS6Yhk3uMObybV2AYWBI0xz60cpxS1yPmY9dwsb+24RVfm8oXzVThR08YaqY/l5W6W
yK9TAXlS3bcBUqR2unJGXVotzk1nxSNPkBS8hOBEs2chanABMegWJTmSr3VWdL0fHCdd3TZtSW4P
niDhK47HFT8tLU105VdcOMcdOO7Pe+SlNuSvZ2rcd2KEtSXWstiQytoqRG714pVski79xhc8EicL
2HAYBolzMvD9HNfBxz/3/HXhLCpdjbbqEJsFklk9kYlsGeJP6GQU6woZIvjkgBg3092YDKZKj5jt
KXwaRxXUUC79839/aeBeJu9PwQiF9UGz9CW2Ek6/Vbq+xcZ15dpwqemXv/+p6Tba5SwELvmGLe/i
HeaGMO/zskjGqEW/Nm6GAbHqgG/SThbiavP80XZXk+n/o69eOXFdobRiW/c9DxDmdHtoYMo45OL9
ZFENllbyaI90a3n3r4nrKc/yDenkUxlVeZ/VRzjfkf5gt3zOg096rbFORpOfaB7Rhx0YE7j/WaYw
yhv+GXMa+mU8XD0liLFtMQQ9yieo4d3IuTPQx9DPXhPEhT3iA8ZB/X5oqAhFcZqwXabB4ZdMcW3y
InAMRxGJAsO8ZGbvPrIl8GvaJT16wK+zKUnxBBGk4zTPQ/WIjJOXdACVLushp20IYoP7Y5G00fNs
+fyPqePac79xtvWN9nQMlr16EuvyQVYtVHitYX7hm8vqNTriBSJfMAdlVlpUNXJOr6WeL6x4l9WL
94RtFW7PT8tG97OldIUIpL6yUV5q3NniJRn7emCo6uVN89+ON78c5Yx+4ZoL6CHqtIuEWOETC3qS
CqnfzmH4zm8BOde9ZWMAvTqEtHvV3Oc4pPBQ4bs4nd2b02Q8KmvKpzzudZbMJIuHbfObKS79FsP2
wOolKZ9WPX2baLWmkY7Ws9eouEQT8GA+4XMCPubivZbNc5cMf/k17Qx4Xbe0FcyiadP2WRJ18jRF
0nNfcUZcopYf6WoRqKRq+sw2t72dZr8Bd5npqOe0gmJooFZUmmckyMuU9f3uN8ddVKqIw9oiRkLP
zUweOVbRh2pZZ7/D3qWkoPUa5Xy1BRKd9bnoT8nkpaGEvdbZDesjwmlZjMUTk8Pt0G13O9v+8Zsp
TgaMNUOkV7oV0LDf4xMT844Kc2n94lpXM7RrhqMJCTpeH7hjMIK7zlgyL6kwKl1Kih0jEpoGn3Mp
tvBxY1WYSSpyv7DQxaSqEdX31VoFamzK/BZGsPtpATrsNeyuFJmOZTzDtSZXte6fg3Z5sw7Cc5a7
kFRxoFoRej5YQ3WLs82gSiXoR79J7gqR2eWgAsXFxVMg6B0nnb7rbVLc+Y2KE9HKXuOkL/vyKd4P
c67CUma83a/pYV44PV1AKokauMptaH3a3u7Jtzn/4ddrZ3XCZbcsRoJwItL2TohFDeW1et9LNyO3
8qJf44YIEiA8rCf2jkMlO61pok9DV8s32yp+6Lpt1ZAX61OwLGu2rIPnu6pbljHjpCtAuRRPthMH
NBGP9axtW528Bs2F8nfRErtPQj9xDNpU7HVaL9pv13FZtYDgKw9MQgklLPssCo4HG4Xas+PO0Spa
bTYdMP0kx/LUsyVjfj7lVLq4WrJsMRJBBE3nokqr9vgSFYPf06eLq4UDtDODGm3Xo3hMyuFH10Ly
we9bOst22URRQxtcP9FBl2kb2upuQ1TmdxVwibRqawJbsxGtz9uakkSc23zZPbvurN26FkbTpdVP
TTWFaVEFIltm2JT6DYxzuMJ0Gp6WFgNzjM0nmIp9TObCS/mQ4nn219u/7pIG+J9BiAdS/Y7l7ceC
xcZvI/4NRCPtuDXhitlCIzwxBg8buDGvMXExtA4BEu1DiWPV4vEhDw+abnLxfPoJndXJdTsI+Gbo
pzjYedZvEYLIYuRX1v5LhPtKTsRF0eDIUUO/IwlUFZA8xZPhmA7S2NMB+SLPkX85vH7KGEHEINlq
QgM1w6YL6LGGRvzmecdziTQZdImYjdFP3crb7IjK9xMZ/AJJV6uMLgTv14YmqkAgs1frnSSJ3yJ1
3SHrSPdVh+d3FUPyD/VTyXI3xxvzyxy5KFpTynWriz1Rge1N1owkPg35/tFntscuiRbPJRvw0IlX
djmd89K+GeP2yqi8TOnfJ2PsEmgNrSFU1m+BAlXQ3rCp2+6rPJrvVzHzv5Gpqm68foL7/A4h+CbX
65hAQECfArvvUGPxhDtjVw5tL7dYHrjmKXiLLQ8VbOnuUF7mdcGOXcZN6kQ2QY8gO9+b8DwPENFb
2yC6Mv7/u2a89gGce/ByxLo0C5YqErzVKQzD7qHeK5Ft9frNbiO2n5BaBe3OMt3y5Tlm41vThvlp
T1682RP9V7EJcWv3Zs3wLAueozvedxE32TDw8HYxxWezGP2el8Mdmce3UwUZGXi+dCmP1+KRkKYC
2SU/eX1ll6Lb7K7xjnLkqsAPonaAtbMYPvi1Hf26pwlKAXqRQKq9pMOpyItngDTX9K9fNsbXvgL9
tfGjMm1plx03KdY8SguNrBbT88o3vtS4Ex507QC3kjBKVN7HjzOTL3Sw587gxAZzGxRBI6pEmTHa
ptTYMOiznk2NXw1R7JJ0SbJVY0FJoiDxOmfbknzFc7/XZh+7IF1ElpEs8SoV06EWp3kttzIjbRBf
ieBfltArH9WF6cjI8Fi4YU+uaz1mOcRZ7ja+VGcy68Nvc3CJOlpYWo6zSNQoQmWGFpytbPwuCbFL
1O28PPbVoOIDgjGiSVFAD3kWm/SaeSUnYtcIs0p66F3kNlHHLAYIz5n2pg1aeeXZ9sK0d7m6mOaL
YdDyU3qxf41B+PfOuGfHneW6HSv2yKPHiqL7qWnPYV94nlPOgjoOSHZGfYcFxdgNB1mKQgdy7YH2
wrM6aKpftxnADG29VhW+6LpUJ1su8maix5Q1ue0faFfUJ5yR5hueikKamlHk91vcB+chTsxtZXBe
rvASvjJ1Xzf2gH6B/LUzuSDxIvooV3EfTg+9rNuHZEOyLS2PUJ8badiAu4weP43bmDcZMPJoTfkG
GupEiSgf8F5XnuooHpYUxcb7Q6OP+eblCbZMw6Ksb0kNDfg/7/0XVrJLs+CSTJZiHKRq56g953SO
Ho/Wig8wSor9jhcXYmkYVPfFFklVavavpv23YRBefhY0dn3y8qqByuXY4OgqOpaF3cjT1QqvWD92
GZbJHuAJploq3dGPHEWZ2RL2X/487heWsIuwiARIKaihWAHuEOfCHLco/5lOXo27YKCFKlakF5mo
kAVvkmm5Jdz85df0S7T70/0HIVsQsxjR5nDQj+04w5VmHf3q06H9+mvjRYOVcJgpUdHC/qr77b7B
YvXr98t3+Knfq4joyLoZW2Yun/OGflsT6rcbu0ygqOgUTQRNT3R/qHL5I6hiz6ad3djOBYeOFJZO
xNs64/EMtULIYvkNiRM8FeUwdauRUiViq0/5Ak7aDvWVPfDC/HaBQBblje2QRldWgs4K6+aAwE7s
NwldRCuB92MUgiJV5MiX2xzidih5Ze//PCwvM/mV2MYFtNhKrcUTtMR9U6y3W1OFKYvz42S2AztM
RZIr99oXzu61/8f5tlChRFktWySi+QWphA1WewVU8kl/EiKs78JkBb1awHnizz/rwgdxhclskAzH
XvexGvrwa9JWbwUhXhnA2CWvJPR7aBGMsWrx4Jhysbw9eP3s1W2HvPo/kUiwpbCcUSO37/tJf4Nt
rl+o44qSibiYha4ozqWpy78soig/wujWy9eSxi6RJShLDluj43LP1xNE5z4PPPZjN2MXyDqqlfZ5
jsbr4ZDpY8IAk/15vF9ClFdmpStDtkWsoAV8c9VQRexNVLHqoayq9TaC5WdqoqG8qckS3LSh7q+s
twvrwBXeqfO5sHIbYlW2HHnMoUzLRv+IbaRivNycqFk//PmnXVgBrgiaKROJe+gSq72v+VMfTCQz
QexHqcUu7RW9aE0XYo3VEcfgnocXFVUb+J0DLux11MMChKsSyLAZc9KLmc7Tek2/89K4OOdA1RXj
KOJeKIAUj8bWt+2Y/+c35E7Mz8tirSG4K1Qky+R0VMlz9+Ie7dW4i/LUyzQcbBEcmQXs1rghFu/B
3+grDzIXnvZiV3qLQ3SDznWH6ZKwsEvbgk+fi4RHT4mdvnRk2M9dfcxnLJYlHew6v0Gw5acohoDq
12hlkeFkISnGFUqV9Gluo/qGUcP8zmZXj2pZO6r3I+aK7HmEQz9kb4+wi65dKS4coC6UY2gxwqI2
FioZC0iM7KI6QaMaN5Z8DO27A09FnvGiy/mjSPagXIZcCcKmv7iYbGa56a8c0BfWhYsslpqETVUx
oXiRyPMI3UQbel6Gf0MWZ0329Zi5WtvxQffRf3q5VotxqdvOmjNhicpglD+rcNqXM6d7dD/xrT95
LToXWqwx5ReA/S9DbpesYw07cTgD+zXu3JvXIBJD3TCMyrbVKTJ7wX3UxIdn686i0mPbjyvBbIlJ
B2vf2pJbJKD/9eu6cy8q1xJF8lWCzSiAb3JHFV79/Gp3YlefakkOo+sCG90k6jDtj+VmbArPXdQl
usZhRtF6d3ClpyA85SZHDQAcpD2nS/TrRsYH2+2lsBjzrfwRr2LLeo1KGb8xdyLoLkeJiREN5qJp
qykLZ1CiImfcr/omdrEug+QsNkeDcV/3v0Lk79KZMc/40FW/2tt17EjdclWGQX4/j/1/B3SP/XZ4
l+vSB8fLE3B5lcz7dJ+vsruB/Me1qswLO4zLdcW0LmeKynXcpcnXkJFHO0xf/vxJX276r4Sfv0Fd
04w6VnlQxeqavmtt2N73Yz7eaVtXftu6i3YhRNiGEDY3eJfrAyiOxSns54XfLctluxiqnghvAqYi
AtkfzbsbXkXXpMYvjfvL3/+Uw4jGQzbhNqDxcptTSD8+iPbwu2e5HpMBRd4l4MXLXA/hWrAh3w6v
X88UiYt2gb/KCVSxuSokRIsak4FI9ey4E70unGPKiI4rWO58H6vqS035lZvJpfF2TtK80CQaDXod
1fLtYavblVzzor/Q9G/w1pEXbV+UVEWm4ye7DX06dIEfRxC78JbJiy2uWE8V/Nq+kDI4TSH78ecF
eqnjziFKbcv5UMKgZ0ngzgH/rDbtNDtOfq07p+i60gMEcMfUTNrPCTeY5YDc/O4LLr7VLyiAXXG9
VXgOsGldaZ2WknmufBfg4nLuoRiyMgUF7D6F/e4/h23+9hsW5xQ9hliPU7Ix1TXxDzqGP+TAP/o1
7ZyhY9nJpFwFUf0IR9IUGpXmU8vk6pVjFL/xA+HYrTocqJp0x1PWhW/qZPZbnq5Y2UilGBEXUZyg
4Um0dZiZovBj5mDf9ete281bGea6jRTPzX8MTy7G+K2g38AwCF0SBlN1FR7sGeKxbxKSeEaKLhdG
163K9bARNTMIUsSrQV5Xy9zvPcRFw9ohKZOdjUTVxmRsh6pj5SdlELtcWAfgoI7IgKYZ/57o4q8G
ChleM9yFwlqKhz7A+VQJGAJAECP43i+emU9XnkyO41pG204Vqebw3HTyZk0K38adVR80ia6GWkeq
aNuP0dFA6bKaP/sNirPs+whaO+uMOspusia1o3jukYbO/Bp3juS9s9B0kIaquBPtP1EdFu81Kb77
Ne4szGMw8V51C1VjsNu7aKvfdbP1e7XAI9yvqz7PQxbqlRC1D8F+E01DcJKbX/0JMte/Ns6iPRoq
yLiruW8/rPEAm5/Zz3NNuChV0ZcNciwzUauux0zDaTI9CNAMnzEXrkCYPvKmmntcak3d/bB6wwrq
/NRuhQs2QeSpEUdFQ1VWDb+Ng2bOIokKN7+eO2tIT7rUBelD1RztaTb0MWDVP35NO0uogDZNT1sT
Yjc8VMHlp7XZvIo4hCsPto10GCzPD1VbeOJmqJRlH+fF5h/+3PPXL1kicZZQMzP4m29hqJZtLppT
XI0dUph5FHzVxdBeybZckPUXLt8EUHY17aFDFTUlzzMW9eYvEzYwljw6k0nI66aWtVAni7kkFL4C
8KK0AbbRI9D7v7wvivOff+7rIatwZVXCpu6TgTWHghLNfisD8WVYpJ/sqHBJK0jvF9GS5Lvqq8EO
2TRCgzclLZGw4Mhl66cvJlzgqreRiKcwOVS7txaCEZvIGt+wW7isVdvncz9NmG/Nvv1IQKBkrC6u
nDQvofvvN3rholbtmiR7bMmh4gQYP6uo+VIsmp73sOEPy9hV3G+pu8hViPHQJY0PZMn4/iUu+ZgR
yMZfew54Obxe+x3OTtIf61DKqjxUEiXrGQUs1fdykOLfABTfvYi3Ap89HMZztx7kJDgsWFhMAviB
HVXkFckI16BS07GYIKIYqoP9F2MrTsew9MstCJci1sTOHR5PQgVZMp418IGPynq80vH/lUO9NnjO
jrMFJO5RrHuofQo1xMwggGGhbv44F3t3yitZ3vIehYGbbdosZwdJTVK1WU06mHSVSZ2KKe/wxE+n
IpVjEJ0hY4u31GKFDxMr9v226sOoOeXt2HhdRIUrl7StTUcnU1tlo2k5TwnetY9w9wvT4dj1ayTQ
l714qUJH660uUrzMrzd4f9r8+u4iXWEwNnlojX2haFDPuZu0kNrzuHZhLkOBIU+H3NRW42WqNRCX
hKGEX89diA/EbVJPO/ahgMCEOK/uOvzhtz24TF6yH3NRJt2hVrZ/HUxpwJPyZ78TxkmKtEzITZP2
UHDV+rY+H3X1r1/DL5vqTxm/GcUmozwmbMxtM8ALQCAdnS7wu/Qc8JcI4af2TXgYVHQXh2IQHXwj
t77P2Lhcc61mr2+ZrhLbkq9t3+f9oQSbaQrnuva80+4aqXCpdWdDrueBdsOA1kPK81QUQ5iuvPaL
wFyuMEAdwF4Ysath1vxDNZH9WUxT4DcXXbCw45I1NJC7aovOnM2OetSEzX41c8JFC4PKsK4lw6pG
Rv6hZKxOXUn8tEiFi17pugJGN1jUTTRrlU2byW/BLeorB8XLVeiVc8JlrxDRRLQtZquIqOMbm5vI
nJIyjB9NzatvPKbjg401SIJknn1/kRPH5zLaegi6LcoW2GyGEbXe4e6VMREudIVkRjmwSS8KrMJy
n0eE3HAUCvsFti53FbHNiBwqo4qOBDaTZRzfErxR+7XukldbT3bgG2JSdcvuzPweeLwXeCVc8GqK
EjofHZvUVOf/heWPErZ4fivLpa5YY+M1x81Mtfy4gXfamM5b+MNrM3ahq2A9UG1C5wlU7Zu4tn0K
+Kq80u+Xk+KVie9iV3s7VhwlepNK+nG84f0+nwF8RHcRzL0f2jWn32K9Xqtav7Bz/gZCrQSX4gI/
JDokSXmTrO/sNFVf/YbJ2ZdNMvf2mKMRNTnLcQ++fU1hZ+UHKwmXhNpFp1GH1YwKLuHftzxUHPXS
fh130lZRW5Opi9mgUC3ziQf2a5kEnoeVK2k012uykhZTvp2mTlVU9KeXbcdvqbokVMeDKA+CdVRJ
h1o1HoZpYks/uQrhclBtVSyjReGTwl5WvYkPoCQm6P1MzYVLOkVTHVg9bxCMq44KitwLCiHs/M7r
i7poIWC57kjgm676er4JwsakMK/0qz0TLkUV46ovplUMylZxcDdVSXO7m8lzjboQVRQQnQtaDqpt
6XsUIWSNtd/+PCqXMjMuNmVR5oRPOQwqopO4y218N2wrjo4uy6PuOSD8PCbxF6G34sHMunrDWsBP
u22uvSNcOOVdsGovLFI+mx2UJGbvUdJi2O00SPpvWxT2Ea6smqSbibZv5VBUnlPBWdwwp4a5m0x6
1ZJpeuy6sT+3LRs//HlIL+yorkrcgnGrJUJdFYLiPq3B/Lk3nncAl7gKt6Uik5l7NbWfLBIcaTe1
25Vj50K/XZG4uON0SFrWKZh/nkYyozLiWt7nUtPOnWi3doeeRY0h2eT7G4I/vIbadQIc+1juldnQ
Lgp+4DBfpyxgfsWqwiWt+mgKEi5sr7DNDTcx1ErPEWF55tf1l6H66bZV8y7/X3Culjgnaa+bdESN
qWfjzrFbQ2NtMQHp1JbVbRin0956Hl6ucBZYhRnxSdSpsQjbRzGM6yPt/OpshQtZNXSYClnyRk0l
uT/W+WNjryk1X5qCTpoFctpNlcdHqyohv6IMTafDVv7l9S1dwqoWTQ4aZO8Uk/TDGtjHiiMG92vb
eSjqQLWGJd7lVMBEZdKmr/QjhARKv63QZawSu7DQUGGUtMuQlabaMxvunseii1cVstvzliatYkn+
LSjzI13myW/tu3QVrWhRFjIymCsTOR9RMJ1qUvolcVzlrC6fGYoeX0Z9DO9wRfk0FtHtnz/oSzrl
lejehavKiJUV4btRqHQQf3cy4Cd+4J1ggk3qlYrsC3PdJayg77NHed5hJ2fBB5hZQHA2Cfzua651
eRBHtLLiMIrZVZ6CeNRARFs/SUHhSmiFjViIJrpVsl33LG6GhwOm7FeW0oWRdzkrPhfCtkHXK0g5
TO9mRrdTnMvhjclB7Xt9XBe2enFeR01h2Sl6YDkd01xlYuiKc2nDwwtZRPXwrwdHr9djk3OFNSU6
BdPku+UQVzIuF+aNa+5YdOGBG3LdKEubUsEcND9XNrJXxuZS6y+f5acTr6pn2+d26lUDMeK6z5M0
4Nsnv3F/+T9/aluWETSEgq5RRdgc93rj8rHvbX6C7/O1R5ELt/L/FZv/9F9sEAEJV543igR9+D7Y
NlOmUb1Nb8pKgjcOKnHeCyqu7BKvDxZ3X8Knqp/GAYJyam/3t6L8Zzr88EvuGmVBlUFobftGjQf/
lATdu6i+piD/eqeFq/4VjpqCTZOdmuLJnOfx8Rion6I76hF//cKBgcku8tKIO7ouTptqfSAk97xg
uYDXXIbrkGxRo+augAJEsNapHgK/VILLeEk4D5EWUjCKkx+7BG24lsIzeewyXvW49hPdyl7Ve470
VkLr+2lZ+ZWeC4ztK0eVy3jNNI6mMhiMmoHAyAdGeVFloCY3WCzEXH83vPfTyBAu8zUCVFv3vjUQ
wQ1v43l9369+5m3CZb62SdI66rZW1U39Ddm0v/sAEkBe+47LfHUbAOm+QxBSJIUZMiOq/UM9aZRH
VlDF9IvmXSWwZjF1TghiNDttaybNAY+7/Joy0oU160qBIRJBGcxOjSIRSzIilubcy1FcGZ8Lm6ar
BsbKgCfNPOE8T4bhzbblLSx2O3ha4TW+WjNC4/52bwy5wplcOOFdeTA+deF2DGuLtzfSwfRgo8Dk
UMRITPn9zx/89eHiLhTGNCcGNao4IoM6lRTeFZRrP10C7kJh3ZRPcB5G41vH2GNDlttBVNd0Yl4f
G+7St+02JXYOeywDqLmck2L4r2Fz+VBTaq587Etj87KN/HRCNkkMi5qJNMrQLZtyuA8w23zwG3cn
eJiTbS+DZjJqFfp7EfQfp2C4ElC9Pkd5Qn/t9gKLnkPvW6MGvs1/CWCWnwdUe+q0rvmYduXQwjdU
+rHE3MW51mbNRzyc4zPwktwKO5SnJGeF11bBXZprle0hkHDHVlFN30s63RGoRHvFb9xluFZhq/7Y
e4OMddGebBG9FfXcnr2+r4tO2dagag6+ccrEVJ4S0cfnGmorVw6yCzPTJaaWEoYkNFmM4rZ6inBn
SZNx/ubXc2fWLwUjBSAWozor7rtJFKmGs7vf93SBqbI9wrjL+1ptTL6x4fbQzIvXzR+vzM6035cK
oQmpVDsUkDQbOpuSab7xG5To18YDmrCljrdKwdKnyUD7BJkmh9cVlLvoE9Jxdl4OUqqxzT/VuCce
Zr7S9IW9wCWfgjkv+wnliQoG5SGy0WWf37N+nB+2sCPPOggI3LhNfaXA7dK0dHJSCVQQ23xfStXJ
JbmDb6TOkM/Mr6zXCxu+C9AUkzaC10epljnvvm77PN5oSvaHGb6TV7bOCz/A5Wh4Xu26tHOp2jJH
ec5UHZkZCDt5TSJXuWjOjYSyrUbrfL9fO1uc7SAmvwuW62q4T5vtp0Zo1HSsb3u+3OXT4Wf2w13p
IiLsnDMTaVWBeMyMFlEawEPZb09wSZoalbPtGu9abcnyd13AQjQu3vuNuLNs48UsMQX5B7abf8yn
8amJ2r/9mnZO2ZzpfpalQdObvFtM95ma4F+/pp2rIUyl83XSg1blAl1oxg5c4YQfnsd/w/MiO/R5
FwSPsZlOWzPdr6T/7NVvl82jwRYih4amc0I/0kP0aRXAEs2vcSdvPOCsXkVVahUgZXe2AJIhuVD6
YUX8NyQqWJeupEnwyMP2uWRW5Yv0iwRcHkq3qA7TlgaPsuzjt/PexW/1kvsdei4ORZdNN3NfaLV0
0fpWFmw7D4lkXnlX7vJQexBvZO+4Bg9FXqrPS+jEhuRKnHHhaHJxqKLE+mkidL1cyqBIk4ANbzl0
nFvI/dP5dsGL9okkwbWb7evvstx1AwR6uUqybMFjPQQlz2zQladOi/mHNLO4QbKtvdn7IcgOxgu/
LdkFpEgA27oyLoPH/Vi6H4EM5hMuFLlX9SF3ASliV6LttOAHkf7bVOjnGCJnXmvNpaOKvOMNpINx
logfkNfvTiXl9MoheOE7uHwUiyaEIm2gVSshxNSIvr85yFw/GIPXIBMlS9qgrP8Bb7V+CWbuYlMi
X5J2nqfgsbWYxbKCZWfd+xX1cpebKliyYvYit0Zsf4ZE53M/6iux24VgxMWm8mSOKnCIyeOy7h+b
rXo6qt0vznEhqWLdyqBFyYJi+R6n/bZ/nnPuOXmcMzfcdkjLtThzWbg/RLH40SSjH84IZ7Rfw3BK
7VQKqE89Lu10b/a8SSkhod8Jw51jd2HQQuZ6yx/rurk3E/uyo37Vb0E5gfFUxNG86ih4BDP5H+m3
/paS2U8phLuAFOzkmmE8bPI4h82PgoAXHpFPy7x67gJSzGBu03zEEdBDlkGa9WscLn5vwfw3Pirp
h3Lc2uRxr/YvMJp5t/abX3jm0lFsnsvchjx/LA/IhB7R+m0fub6y9f5vvv2eSOYuHmUGzoTGQfII
sZ1W7SSeb9ZZLk+6WsLlocQl4nZAyXwKg938NtY8eMYW197vsKaEN+S4bH+TZNbPlMDEKIWgEctm
Oycy7dd6/o+hDOZD3EX1v5U4mE7p/3N2Jk1u21oU/kWswsQBW0rqQZSntB3H3rAcOyFBEuAMDr/+
Hb2VjbSsKmy88AJiY7y4+O45ZR19mCsTF6nREfI4heTzvwp84F+cCLBNQV83IB0XdmqKpDlMCZm/
lUm3P+CBAUXBi9bvypIGc7pW0wJjVgTCaRfIaU5LTJk3bSR2mGYzdoiKxEBPqSFLKsoSj/PLEGcA
L6ovaxKUkOdMbPjAlr2+FDpoHgOI6T5Hy9LhkxbpB82FLhzWiRK+EJzDEroeVbpXI57y/ZwdQxcO
28IRnP4g80sIE5d2idp0ZthEfr9UXn9dCF3yq4tNWc/XD+9Q8/7vgMveM2xJ/1GxLt4WrJ2efv8z
N44FV11rXLsh7EWUX2hPHvOkeVkQ0t/5E2617exTKmogf2OH5JITvOsEzXYKRe9nGoMisV8370Yn
0Q5kIr9EM7+oPPwEfUK/QNVFvXKL/Ewjx+TS0CRPefASUHqv9O5G2sF1SkzauCVYPPKS1yiBn/hW
POpxpgcz7n4Gx6GLfUXajrPu4YI+RaNJI7G9qeB/6zemLva17IBz6yBKLkjKPNO9oofW0srveHAF
tpgFBx3Xe3KZQrsdr9ZXh75ue7+rE3dCiaJVU1BCr/3Sj/kP1dLvcHr94/er6Mbtw8W+wn2CQBWZ
8ktphT6qgtlTzOGvXSWw7pEm2J93iOff+bEby8rFwBqkZVaopeeXtasYknDmfahjv1SwK7WF4nIx
lAq7zjbJ8dDL9VQssR8yCDvTX5esDcWYmHDEh+ekeehI97YYcz+1vdBV2kJpCoMRM0bXmkRAiiCp
TmGkk+PvB/hGn7sgWKjXCKoBiIrGMcoPAe2rVO6s81tULgg2djFsH+NQXkSHZz94gNh0F9Unv0+/
7kQ/vTsVFVVX+2t5icwMGxbyQ4ncb6N0ObC5XId60+gVqBk/Jf1TG/d+txUXA+sKuMcFO5UXGD29
QYktBD3CwS/L4fJfcTCYWSzXr45QYE3y+hAngV8JQOgCYElNd9NXu7y08J0pu2BNBTwNPOeJc6Bi
2hU8N0Je1la+NXoejiWplN8Ud/kvtfERmgJFfFmVeTQVt4cqKT2Xvkt+jUlVNrUqootaVcZ1/pys
nmG/S3ytpYraKCyjC1+KITV0eWSD/Oq1dlzkq6MlhbNBFV3q8c9JmHd1a/02cVdhS0NHm8SVii6N
wmqXLHomwrz3++rrJvbTitfYmWiydTBHnIJLYL/yen/xa9k5QtecakPota+DiFxoUAVP64B0m1/r
7NfvbjS8y4ZNRxfk8kIIAyzroU7onUD3//P4lVuWi0jNullh9QD0DWLFWO6bmclhraLiGTYuCN9D
+UMGcZluyRpmJNTRN6xl/bSN2HvKvOcqLWqynCI+hXhmDFicFjjQ3q0dKyneqJv8sFU99dtYXTCE
xwmPFtmEl5Wm10k9+j08ugRIVMxtWDVol0TRAh2TlqSmunONvXFEupRYzkZc8BiPsQ7rDLWWPIXd
i597eehSYktnZFjSLbog3fE9IvrLjNXoNetcSMzAqhysngwvmyHLUZFheeDhfi9BeaNXXEisLqt2
pEURXnorXsK6q1JAP355IJcKWyWFWU/EwovS8oD48rtcd7+Eh0uFBTMstMNAhBeJyzNkaCyyNXXi
eUi6XJiUBSKzEaIWkNP7xybQdBPcz+s3dHGwvamhN24B+SnRBRDM6VuoRtylPG4UhIUuENYwPrSN
xWy5QkipvRpRxBFsi1KK8+1gioS/L3I2fCQ5DFMP+SQHlcLXSj6abVoOdOo3r2krXNQqH3tLApmz
q1Hc22DvLqis8qroFy5opRTSC8M2i8tY8ovu2gvNC8+mrxeon46mRG1zZLqEX4gF6xbA8JlP1T2c
7vW1JlxlL+xpisyGs0un5iOPmke6W6+bqXBlvaYu7EbAkeyCh9STCsusXMM7Tb+eERD/YZmFwoOC
RE9HbWdgk7r9y8ewP+41a7wuvsJlmnumTDOJgF0QSD/vdDz7rjbh0mFttVQEIlnsMmn0SUQ+dI30
nCpOAp0iEJCr3eiFJ/mcxoHK6F54bW/CBcFIqLquo3TD9tZXR1nOcQoFG+P1UidcFCzgHUM5Ukku
3cp+bEOPdxF158NvTBYXBGNzLLZ43veLKuWWdfo6ySdbpVYKvyhMuDRY2Kx7OXdsv7RRr1OZ51+6
St67R7+e1RSufNYwDEYVSb/j9ayzH40oqg/N0pdfwlUVT6KvBr9bgXDRsB3JR6zibcVjgHxBfSVY
0ckr0BEuGpYzDR5yCZdLYpvtKSja9hDPsV8diHANC4nEIwZt0brk8XFKxv6hUUR4zkwnwp7iba8L
O6JXZr2kwSTf9Ujn3Qnfb81NZ8HuzVwPOy6RF4XN5qCpaZ5GlRSPtqzZnb3yxg6fuBdgjtfXxKDy
uWjBskDY6zC07N7t+sb3u0RYQIKGdRtZLvEWw3WbdvoCVRX1zuai84q/hUuE5WXdw4RjXC687Pun
MYCMdYVM9tEnkhUuEQZxmRYS2egdDhwhbRj7wuPZK9YULhDWN20Fq69mRdFKBVEDGacDbJvuzJwb
w+oSYRWb+wG2PeuFhK194HDAeSQadct+3XL91Z9iDk0kTbo6sZcoMcdBDe8WM97Zjm99uHMftj2X
eadnezHB9j5pyuTAinn0m+yuGCPSdeMkOjJcmik4zuY7fGG8HtUhrvdrjzARRrbZ1/EiJIXbp2lP
i639HpCFi4TZXkwr24LhIoK2OIgi+RBUpZ/VrXChsD4WOqlIO15K+akmesa1p/bsb1evLZCWoIAB
bc+i/aKK8Q9Ut/qtTBcIa+qu7puyGsF1BCqFnGfPp8Zv8bhEWKk50l9hMeKGCTqiZOQQRH3id2C4
RNi2Gl0M9vrhpd0PXZufo4kzv7jUBcLWuoUuCFx9LjAZe1OT+NsmqxevNe/iYHsPudQV5XaXHPIu
acWn90p6nv8u+zX3M47RRA+XWZN/cht9JM3yxe+znYWJzPFQLxOazsfmbb49kmn0uy66fNcc5mUn
YRN9KelcHJtO0QM8G+49Vt/YB13Eq4Gpct/BSvUy4hXsDTc0erim8P02QhfyQpKubcIi6C6bXD8y
Q9+UXf3Rq8NdmkuQChYbbdFdoi3aHxpNfgR77FfMgk31121237u+rlAFeJmK9W8GMGWe7gZbt3r8
GsT8dKjFuZRm31R7WePlTTR0h21ZvZLewsW5qrCsobu/mssMi8NMRtI+E6pDr+S0cM3/OvAeswCz
dEFoqw6oPjyKFUZ9fsPpxLe8UYoyJOovBsrIp0608ylOeur56c7qzJcGDg0r6y/bJp/D8MJtdCdE
uaY//pubFq7mlbGCVXjDMBeZ18F06m0Lsmckc/s9hrHtB2rL5Clemr3zW1Eu5BXXEpaedEI/iYic
8niWh3ocvnkNggt5sVBDxzeKm0s8BN97E+s06XPtd2a4kFeOulG6B1JfiqH9RGFQrCT1C+ZcyCsq
yN6rqdWXIJ750zyGxybfpV/k7zJe4aYky6dJX8YQTPIUoEg4IcgY+nX5dZf4aTfA/ph07VzpS6hJ
d2ztgOpLyPN7ts5/bd2uXamhqW0uexF/0+12yWeoBf7+y///ovvK1Hc5J/BHiUQRqrmgd+anKO9K
k/Zm2I6z0PotlL3UQ9jT/f2wxPObqRq3k6YtfQ5NUGHviyf4galGH6+boUwX0eTjAVKMfZZXs6Wn
cAD1xXq9obehRn1oBMKBtirsGzjO+uH+wmWoyAzDpl5h9fIt/mEFfeznzS/X4KpllSyuNgr3tsvY
52nbwVwznIVfGl64CJUW+9rTCnmkhuVw4Orf5bWnPzlcRX+dM4onlmMv2zLb6qcGPrj/lktb/vj9
pLlx+LkQldzrxc602rNA2R96lMeFST8WQ7j01CzyHlnqes9KwiE7RUdoWqE6yc9yUrgiEO1aJ2ui
8igDhPAWHOWSVm31p1+3ODEBaVcA2JveMwjU94cVVZePYyz8ZOGEC2dFSx4kMp+2LJ5XluVCVykU
PWYv4EO4cBaSyEnS6TDM1tnsz5RX6tCoffOLC1w+q5I5Hq2LOs6C0H6MkdRJS5kHftujy2PFMCfq
yrCIIHXCw3RBJJlWReinOydcImvSeJHso3nLwJP3D8tY1g9L7ufbKlwiawghsjbGlGdLGH8pjHoQ
Y+dXEC1cIKsiM7bysOZZC5nWTX4yeet3lrowFp4BkigyCcu4xNqPy4EfkFb2uyi5LJblIwIMGAZm
QTVn+QyPbQLLqzun3Y2Ny1XlqkyUG1zXWYbK2e04ylgcK+6ZonNprCSJZVv2I8v2ng6HtUWGIYco
ruenO0FAYlDHTW2+Zq0om780S5bxqdxJSfwyDS6eEaAeDBobDc/iErVtiUo1qf1AZOGiCWXcBrgL
7Oj2qBtSukAJ8Sqk6bXrumgCDOCaaDPdmpHFrmlbjvFxwAHlt7m4sNpqGZweYMmV1bRQKSQzz01y
j1q9NRud+0yxwFJkbwJs5q3q0qUbn3piP3n1iitVJu2GozXhLOt5KR5MgCIAK5F08GrdZdWShdfQ
zpvWrJo2dqjZ9JwHox+FLFxWzag92uciZll0aDbepVEx+E7E6/3vpzhdzzwO91yyrFjFE/SyYJep
7z2/3BhNl1WTWx8ndR9FWTPLj8uUP6Ck755w2622ncjC6i6uC7PEGS35e1QUv4Rb7Hfwu2aQHTfN
UBm5ZkNQNMVhqNhV4j/c4MfhN1ecjSuiG6VDLLCCIMuJh/zP1dx89mraRYdIY4pI5TiIkI6BOcnU
RnCzjJTfVddFh6DECWQNDnFZyHAJKvBs9F6t6/zk9+1OcqrqGOemRSTXBsOYxl3yAHHmP/zadqZL
0UAtPRhnls2rzei0PG377rnbXmfoTyuo38Nok5tlGQRF14dAzHjCTBbimch06SE5rYBgKfq82wB4
tDmvPiYxDzz7nLkfLyHiHZk1a6aYPyQIeU+1Xhu/leRCg3RUGvJC/ZZNJRUp3tmX1BDUcvmNqfP0
CknFCmawas10tFRAPdjwZPA44JUz4i7NNIl4apay5Rkh5dt5sefNxn5fzl2cSQ6kZVsULFloiTzL
crNPEV2FV8qeu8JR2sKhCH5zS1btcOma6rL5FIshPPr0OneRJipFB86p4jgwkmOUkxNcwbxKPbiL
NI1LrIQa9ZZVXdSnAfI6B5gf+dmqc5dqwq0l6scNHy6Hnj3LZNOnHEoRXguJu0QT70NZFQKdTsJa
PVM1D1mu93uShNdt6r8pKejX/rpMY7uUvMENDptAMT1QEvMfjYz0C9/m4c4fcN1lX/sJJ/Qi09AE
kBSn2RCb5F2RqOHYREN0WnUS4AzhfnArd0En2cOsvF9imsVt+UXE/fs855+8pqZLOTWBDcbeCAoU
ribveMJNWkxR5JX44i7oZJnAtU5dW1/iD0QGOp0H8rfflztR2KDCDgJXy5rBtbT+pJtyebfEHDrj
v28+eX1sXcYp3mYSg4VeMh1020tHYWqTwti5OzU1C44718N7NRSof9Blqe+kfq6f/sp8ct87yxVH
FYS75qxtaPi4Bbi6qiB4IIDcPsPRd3s/0R6Z0N//ga9Hg9xlq7aJt1s9CGyoof0DNQDfYqm8zjDu
slV9VC5hZ3DKmCU5zO34d9HtnueAS1ZVcAXv4ZpkkTZoyoPtLN4OEj9fEe6qboVxQyDj39uM1dH8
DOs3e8Jds/eKYbkrvEWF6GZoyNhsGiA6cX2IgiWb70J2TnbexEgTgLfJmrDlaULxT7HemZc3porL
VIUs79agp/hwugTH9UqyDLH203pCVcSvG3VFYtBgBLNeF9DBWQKbzmRZP3jNcpemGlbYbjSwT85w
ga2eVBzk6bz1yZ0XvxsHgMtTrWODIpeuWTILTbWPE4PaXNpUeMelUwktu6nylDrCBfPXTgqmYMtR
CblkamdfpnBKc4u8tl8fOdH4CFquNiaymVVjmEIVpQZH2//l17hzcevasAH1u1gcAYWBAa58s86r
V5aPu2yVxVrS9dLPmYzX5gR3kxYpyviH34c7h7ueW4AEdl6yoRDj49itCTQ0YBXj17qzXGFIsEQx
75esL4roQHarU5KEg1/rLmDV5jBOx0OczXbVz2k9Qvtdy/aehPp1zr12TDkLdh5n2TZQyM+QwBUP
BDvypRBt8rRFee13grioFdjocrFFMWZLwN+iGODfhUZ+jp7cRa0MLaqorzHdWVdNp3AmWwoNH79n
Vu6yVpOWUz7l+ZQFYmvfss7Yp3oK4yevaePCVlKWBIfUvmTb0LXpyuRLpcIXv7bZr1vM9cCO8qmy
2SLIc6W/2sKvyoW7oleJqFmEIpwla5etPWzTztKdz63f9uVCURCt5Jou6BNOGnsi26SOAFb8ROq5
C0XR2rKgl9h4CduqzMwlxPBhHOT37S4UtcycxqOt0TrUxx/UPg6HPhn9ruMuFiVrWa8BUTbrE/oJ
IpNv4534zUMXisIUn01doc9bps2pMvl7Q4LtwWsiuiJXwigoWxE+ZQpF9IeCDObQmztt39i7XCxK
h3MNakPOGawN14PuhuZxncb6qJbKLyfHXTYK6jWlKiY1ZRVPyMOIrOujakLPsN2VuzKFIWu/J1OW
gGu5BMH+mVrT3kGKb/WOc+btluNKG5M1Q0a0rp8g89d8qElfPY8Fi+79yI1o0sWk4rk1sIOmU8aq
6clQ8XmLS79ozyWi5k2L5mrwkbV04Ok0BENak+1O49fj7ZVjzyWiFMSbCbyDsT+qEPX1g5WnZZ3h
2gqa+YVOzBxYV5BDn6Pc12shuJgUKrIY1KitzYZuYIc5Is2JFLufVAB3SSm2hBuFVMiQVWq8rGHy
nlfmTjrtxjxyOSklmo6RCWnjyDDxHCw90PeZdcceQkJ3IoRbP+EErSQBbNDEeLBLSrb+0xJZnZYZ
qy4djLwXRt24j7vSUAnksFo24R4r+2r+PlclOc0jb4+V2uhzEY38KdxI85fXYLvPm8GMMW72os62
vf1hqr46RQQXLa/GXT5LEmiwJkNnM82Tz0W3qHQoUNPq17iza5SgWAOyhiNeCcN/UDd+RtHQv35N
O2FyWwmk8abrEQaep025sc3f/dhRP1MU7sJTdaRK2sl4yVjDmndFXsL107Ze1TYoePk1oDJVp8I5
H8csWdNlN+rH0OTku1fHuPBUDC8Oq2c5ID3VftZMfRjaZPcbT3697f70OsNhFQAyYGuzWW1jOhbh
c1+zOxnBG5uoqzxVTtdi0z5ssyKn04GXGSNGpbaraVqHyzsV5/tD2Pi9eHKXdsoNnFJqiMdloOTU
gdMyTKOkUU9+Y+BcbSWRGhrS25zNvGi/IiFCniyFIrZf68wZhU3alhqMwggX8Hf5VueP1K7lnQ3h
OpavHGYu7rQSMdtA0jmbxMbbtF0SfojhIFMArMBJpmMWeM4mZwmLcEygNkjGzF6FBls4S6Us38zh
97104xhw2aco0oGt233ISLTlL8rAQqDpDH2YEkiA3PkN+XpfuQxU0AZm3pNiyeTa0MMWoyBqYyZ4
s7C5OtayLB5aZJ7TZKEM8o64tfr1nEtIwfidTHU00nO45t1ph2f2KVj9+AjuElKDtaxfd0vPQVHy
NN9D8MyelSTcJaSWRuBpMUTjTdmYFPJ+bZj4nQguHxUNPOo4RdMygu5JMhmdTsC7fj+bboSmrmCV
2XZr25jZTO4LQgkOoeasr+P1zmPdrcnqLOlNqaiIBbDmxpZznvZjW14KE/NMrwm/E6Xe+hOcw7gO
WEdWjfz4Gql/8VZ0UBPULX7fPf/HuF7ZNVweqNQDPL2LcciAvJYSHQ+Kebu+HZRwGz2hSrB7yot6
eF62Sh+motMPxOr8xFut//n9J9z481xmKK4bPS8YpSzUUElNkm9R3n/za9o5rmu2rpPZRpsFdIWX
0x9V7KfajCv9r1t51e8wTRQTohhdv4fQB7d+tCB3caElBDJpJB4swjD4gNznN1H4mdHx/2hbmTJH
TdWAtUDUv1GMWuQxqf/26+rr6P4UYRibw9N52/uru/q3cf3AgslzCbsWhk2zmHlKSnrWUiOgW09c
yzu341tzz1m+OeVrY7YCW48G1hB3y0Es5rNfj7jLVo57KXK0XcwK/OFoUAAR+TEl3IUbUfBRcdqq
OpuN+cJ1mClO/IA17tJTfCZBl8eSnMt5e5Ei+BTP9Z1Y8UaM4qJTqo0WY6aAnAvez0/BjshBdF3y
Vs8kPELRaP/o1feuAhOezUy7xzk5QzUzzev8LdStP/k1fT0JfproI1LvFdwo6TmX5p9qVMcZ1rJ3
duMb09HVX6qCdQujJSFn1MD8Q+L4r23I76ko3GrbCW2DvIsKU6BLCtO97TULj/DEjU5+neKsIyxP
zEOGD+91914lPWw05egnH8RdfmqAJ3DV5yE5y2V4V/D5ad78VKi5q7sGeTipkxpNJ6s6JDz8VkTk
XgXV6x3OXHSqHYTtxCjw2RxPw7L9HuCa5DVRmItO1bxLCpVwco6S+qNpuj+T1tyJaG59tnOyqYVB
AWrAZ/OdPlslH4cx9Lr/MBeaGuCnFav+2iPlt3bYzomJ7qSObn20syiJNsw2FP3B2vqUTIdVqwef
mQ2B6V+XO8+roEfke91J6j9Jvadb51dDxlxYim1QDB0UumOoinemqVPFG697LHNJqWKbyxAGYDob
ie3SRK/7cS/HeyYrt3rbOdl2qJAsc10xuDAWH8tgg37avvldLplLRpUlWzgZFDvLOf9SWfklqVev
E5m5ZNSc9MvK7XXV9Plbs6hDZIjf1HaxKN2WcrQLpkk+4z43FQqKYXl89JqDrvJTI4t6K1B0nA2q
U09Q7+fHueL37sI3RtPFohog7yTQFAtezl9sM5zWbvYTTWIukZQku6raeq9BG/Ik5Vr83S2rV+zG
XCSpUizKg0JTIKlBOtn5cV+0Z9POWWmqNVeJDaqMwQ9JVOk6fvEbSeecjFmrZb6iYRR1YINtD3pO
vOIS5qJIIXQm4Qo/72cbWp5W0bCiUhLqI34f7qR81oDVeUhlldm5ekOr5nsf9X4QFXNZpEnsdazy
ymRYQACoCFBankIebPIbTZdGgs+FXWoyNpmty/0pKrg+RtYzpQPp1F8PiLWoRxmOdZtVVfd14N33
IV78RP2ZCyM1Qa4bvZr9DCuSKN2YJSlTwitmYy5/tPetZVWs97Pm3VHo/BPn5b20wo09xTX76xNN
BqDdJgt4/SXfUfY+6tDvGgs37197nIxJ0rbtzM7ztK7NIRyqGHL7lfXzlmYug5Rbhc2KDk2WB+HX
AHobFan8InzmKjytTUAGWsQGL8k5NB+7cX3gSt4rp72GO/9N5jBX4mkZyQghM9lmW9e135ZakD+G
dlYvhZX80WsjcDmkBBqhItm5yfZl+9pU+g1TxIv9Yq7O08B6klOUGWey1eqN6GLyXIf9fGe6/78y
75XOcQGkeAqrdV0ak0HZWx/jVfcPvBXbQ9Fs9MBCYQ9F35I8pWqaPu1Rsj8umMPflmCZ/sKzQPEX
w/meH+Frnj/Wtoy+rQNSHBEdSvMIjcrpAAcdmp8YCYdjocboYR9D4xcBuIATL2doAqLfz3h8OsKw
r06HtWZ+lwmXb9q42kKxQDs1mfe00t1jPd2rB/x/IfdrnX7dIH66LVe7gGEFbdtMBdiCDwo09BHK
jHP8VAGT6Q4T3GHCA6l6qL/B9esJyGvQHYIgXw9WFuI01gJZwXCqgiNrElqlKOkYP/KGkiwvrHos
C0uONWRNHmNUkv8190n8FkXqKCRXUg7HnG4YGHqNagwX9M9lzsuHkIXDm4HheVmrcX2GWmGb5X1/
7/3ixt7nylDlo6qrfkR3RvrHsMiMzH4GMsyFyWN4pMymG1uEJYJ86O20pmySsdfbJnORLjVZO8kC
3w3zmLfR8lftCTIzF+eS8C3B/QDVSXlUHFH8+CUJQj94nLkwV1vDTDIPgzrr1+FFljl8tfI7O8aN
gXRJrjoOWIMiwjLrqqVOp2SoHuHe41csz1yUS7M1Nl3TNdke9PzNGrcrBFQ8XVeYS3MBUwplXkqV
RVX8NiIEqEnjF8O6LFdOVq4biHFl4CL/zoPh006F3xR0Ua7Owv41UEpl6Pr3cYCMZqxXP0tc5kJc
ulKtgI+RygrcSdJN43msKyq/BITLcIFEp3Ggl+AsquBrPSHjgzoZzw3atSwsJh1sxT4FZ76pz6xo
M9H4kW3MJbdUU4q6aHGVn4axerMa9dxrHr33ihVcdmsMtiYqE1sC+R3fEqNtWo2d31Mqc9mtOV9D
EYuuyAwr1+PcGVgmFLvfdcfFtLgpRAH/Mrx2UpWfUAO5HbQ2frkCl9IyHI50AbKxmW6C9dSyPElR
Dfbi1+fX0PCnA3efumRfsYrOyFpNz2Gy70c9ML8nZua69m1tsjRzSZPztIv+jcbDzBPR0g9fYy6c
pcsNStOwGTsPYrWHtgp5Opc28MvkucCUaQdaLxCIPI9U1oeR7se1L/24PuZKTW1FPNI42pJz0LZJ
Won4a9hN08FvTJ3L9zhAzwcuwMlZBbx8mwf8axBNvd9sdHmpZKJNnxDIBkRl9ZK3fDk14X6v+urG
hcTlpZKyGSA9nUdnFFWKh1jw8gyCqj+2Hbd+w+piU31Hg3otSXSe1pkeac+2j3Id5J+/7/r/Qwiv
BLD/Iaf2veekbOLzEI8s/ipoHL8sjSRpuSt6nmAjcog4RONsn9fvhRlgzzTS7WUrhf0wwWj2xwRD
iOZBhFD3zJuGP4TVuPwRs5y8EwhWH2D6RT5RLetHG+3yMEMh+hklAbDH3uFN+/s/4kYg40oVhaWl
wvZ1eA657t5CrIy/GdsIUi5+zTtbDvS5gc7kUXgWS/5XH7QvFCGqX9PO9YEGmDLXWOYcNHQ770m/
HopI3ovUb81OJ5FgEgmhun4Nz1Dn0Cj77KP9wKKB/kGVNX6BgatwNbEQzlrrHCJZUWxfkjnZTnFT
3kvLXZNMr81OJxPfEngbGvhKnRXexP+o+2J9rrB5Fod+liM/kG6A2FAk2D19yuj133PZLDx+zrbd
+/C8yEQeUdO6PZY8qI+QNFEPBmHK9zvjft3aXvnDXECL0L2eqgXvQ6yZqX1pRVINh24w9Jg0gz60
UCFPNx62L4UOiTjCMZKhxI22M0ZwHOBWIK/cLRtC8RzVlfiswrX4WNeb/AD0a2xT0VuO9agJyI19
wfMfHOivQe2HhDTlu2oKikcocC0fGwiqPM9mKMeUFCbKkDb4tFeiOLVlWz9qFNQMTZpwSx/lZrbH
ngfmU8Pb4NI20bSkYcyrtG3U+LlgsOS80zk3+sbJOBp4DDeqz/ezmQ2UFKlZT7Hid5Klt0b4+v8/
xQ98sANyF3V0rrCqHyFEUD2EWrQnXQ/dH6PaqjsvVP+nN14bYWfXKLex6o3scDRAn5g8d3rpYfgB
XiJdYEF0AuNkPkOqoP+O4ojwVLPyH8pqkVK9NanCQ8jjWG7JHSzhxgb5H5pH9LQuwA2fx3b/MUKV
Js01utZruFygJ+hbaP+JgZ3FHH1dddqM0519/cZYuTwPD4q6ihoE7yQwa2qNGg6ELGEa7yI5DETu
fhPOlQKCUXqkaN4zDFXND0E+PZrYk9dm/6H/xqKH9HBMz1hL8b9dnOQPA9Sq//59519Jr9dmmbPF
z/MGea6ZinPYSPlnTKb1zKtIX0QVt6exKNqHpUu2cyySxS9B6gqDDcRuka17ca6Qfj0LTNUjPBVz
vyuVa2NJy34r90mLcy/FcFbG0HRQVL78vrdurAMXBtzaiJMt5Pxs9tWYdGgRkRRLwj79vnlIu9w4
cl3YDwnvrlFIGZ9bEpWFOJQV9GGHQ0t4IFgqIXRC/tgXG40/FPLY0qTVXq1QGmDVEkBMSCUszId0
r3EedCms7UwVvS/wuGibwzDS2ZbwRY8SPNvt7bjR+vA/jq5su05cC34RawmEBl4ZzuDZjuPE/cJy
HFsSQoBAjF9/K/exO7FzDmjYu6p2VSRom76F/2/BPGygUb/V7DO15aAR5uOh4ZapT5gZWEBTm0Jw
RJwPh2u6h8SsbTXuWXJWcFGPqon0uCy2ZTYXh0FfWWkKh+NQ+/EMGv8usXuDKMIOgc7L0DFSpE6z
EvaNMIaLNS7gLGAE7uIjye5aeAs+x4bUaUkOo9d8rq0+wTD5W5no+Fv/s9hp59DknmThVy22+qFX
LX932TY/et2RkxZwRV+P2jXf+7SPfd5uvK0fR9hn/HZSkuisMaXdPop5wvLIJ1R/DovcNFFuaewf
M2PHcnKkyeHOgne820WW48wcel3q70xsNJKY/ZBb3v4Y7JHeZfgOMIzWYSvaKa5LHtmmsM3snsW4
IZ4xGb04DXidTwQWM8tD1tZbX9SsY4/wiK8fo1qYSzu7OMpneIEX9oAj8OWwWzL8gBwbGe3aZb+j
BpZuUiielNQlP1NlyGedJt98t/3N0JjxjWVS9TnGkYgpoB+zJRTcrHTDNJVjGuZTI9UECYiJaoDJ
AoaC4zINb8PUJsgAaTVSTkedJfNl1UdCHrNogwhfL6tfL81Yb/Sn7wcvqqjv8PPzzrZ/OHTa2WIR
3F284fEVL6DHp+waiOuvw6pgDDOsQH9CbhDN17zVSq5wHptstusKx2bfhCLqWtndxRI/mlPTL8Ux
KvJknCJp0WKi6lSr3iFLd17TOSrDtPbqGmxr9GO3zePJYL3ftTsSEGc6TIi4E4Mou8nQnKEp6cqu
dePwLKxsyYlNXpBTlyWUnxq2ZWNdDu4AJpADRO+Hx05Es7xnvvb6rfOek8dexkfgeY3KkRSd7qy3
+CS+jc4AD5OjK0wHKumGp93cnpJ9WscTBmgV/VjCYo6nqO6QC2Mg2x9+J8tuVySD9TRZfQ7Q5lhy
OyxLd5ckpKV3G4gp82kOFZu72Ez4qw7PhD0jxYZE+Y6XwU7asI6f6DRm8rJ29SiLjtQQmOUDQYpO
sUx7Ju/rTmTqXUAbO56gdIcvj+zxA+Xh+gimBOuWhvoZGRCw84LYm68n7YfUfMHkawKXh+ZsUY8D
xUI8y3lZ+E3fDw1S3gZngDcMagbLHRAwuzxZOauqGaMapK5XfhH5lK0r/9VSSod3vyM68lmmjqFi
IRLbM53jgV6OLhXbd5PoaMG05Wo8DN23SF2pgxVDGeum0dfA9RC+aDY29F6SxoZ3O2abvFDKTPRT
uXRAAdlPYpNQZDQ0LaRYh/oNP9XNT4NnBxH5SiPZPRhBpvkMy0U+V6mbSPfainSb70WMdQ1bYBeJ
yid8H37BX2tm6DRbjXWMmIzsPNg58/cHVUFfsqZx/jc5ZOLu93SYVFwsoyezyhHSRflVwIKg+zvW
zb95kh5TJecmhjfJpd3crm4HSC7jC9cZKnfouLf2uG6ZW1ZVWMZ6Uwaypf9O1zmOll/dwftwGmY/
0LsEp9HOqt70dXNjDUaqfi0p53AA4l3Gk7zr1jpVOUbpINtpcVa464bv1DyPmD3qqzqrJ3bFwDJr
37t6n8SNRszkyYyated2xd+HCfnR1xXcQKV/rhNEVLV5E9ukv6CM2VdXsm4h7QUDh2brTkcmYam+
t3gxDxFPwQYiYXZ2/IyLCHMDcWZMuK79vHZfAimf/JL0GI3MDYwrVD6NfBzLYbJt/PcYl2g+uxjm
dU0+jmLZc65ZVKopNpEriOv9/NEnYiNPXdvZDtHlGJRW8JmKiVeAqThgpKnNGnLkR9zjgsqYM/Uf
TPKu0YvwcTzfdHDm2c6pa4W8i228yM+mT+L4Z4ClUXdqOA31bxqPa3LvROrDS9pgkX4vSbSIqwZ9
60k+REmc/klJEsYLPdKI3E7dsnU5g+Lff4llWXad0wUBm79EYqb41BvIpu9tIHy7Wz1Fc5S3i5L2
Yw5znT3IuJ30+4aNsOg8FetU/5S7qaNTU68JPyVi39SdwQBBVHi6x0yXDlAgrPeiNTrbcfbsdgWL
bT6AHSWtx/TSEjdTWZskA85CcJmQTyThEVPiH3LWlv82x7QXdQoqaM2TLhmJqMBvMXtnEsR+m+KA
I8fy93B+sh9Nx5rwEQ4TCbRne7P/lL20+pX2UIl8za2he1+OMuIzO3FDgSdVIQyxvIODnBufkyYi
k744+OHJtcAsafCXWfuNqsuQ1Wb/cpCr43owjKZ1hcHPzJlctnxgW84PZxiHMTKmjtM8JEO03CXS
mzrvsjoVuG3reoIRLh/DyOIKugAup1LTjvXpWcxLmN8nAyMddl6RiAA7zj2FUu6/ZmY+7AWfF5Dl
bq8xCJbLvVMLz3kXR3LBGJDZznUr+8mea9hnqLg0PJNRdwN4fqbPyQLzwLWgW8b9R+O6eRhyamNt
bnr9z1SqSE3cuiNv5SosZpeW4eClXEIndJGBkyTnpouQpQS3OtqwK0wmd3sRURcv34wMXJzXxETD
WQN6kiU7+LgWk3ANCqbNTJqZU9yLWrUgZRbeVbxZjv3c8tUm71Gtu6naZpl+N4fo4i/hFmovw4bA
lpCkSdEG0z0l0cZIzm3cpGekKCt5m6mEbAhyY3LbL+yI6Y2E6/WO+3p19lSP0UJ+dtSqo+JZVLPm
rJLNRnf7FC3xp3QJuSBOIG3OEjm1TQUH7oktRbYgpe/eaBIn9/22wyuoAEqXQE3k1/pJOdVhatwt
i8cABN2v0Tx2lVpn2NUOMxwOF3gInDOUUeN/oHEhXMNXppO8jjZbfZbrbstEJamE8ik/EIvQXVdU
ljg1TGPmPIMD5rOEBqvzOaqqNe3Ouw1J8hIffFPRiQritxvHe9M8R/EEC7uUJQnKNWzdGB4dgnaZ
/qMi6seLNOImlml/1QkMpnDCZv37OmRwJ/PTYU3ZiD2RVxZPo8SfTV005RFQOPPH7jXmL45FR/oG
lTWnv8OIm+sRIj+XvNTDQex1CRILkEOfAGIjNCy4M7LIPT6JtOkxX/D+Nvt8cIa808mZvyCdcBk2
9XFRiFf8FmLS85SvS7cMTxS+3POdGPTePFKMJbHHfQO4+2OnkOFeoFN0RudLqxnsqVu67ydEMkz9
VxbHETu1KhD5ns5iXn+wGULvH7VyY/3Z4LOi3rFCHPq/OghEpkMwfGj+eLis6TE62baB4JsR3uWa
tAbDFVO6Y/+O07LFBRBbs+c9SYW6SuDbp2broXiCf9NgzoldxISzYrPNY81nFaGibAlSLiFrMJmD
ZKRapEQQMeMEGY8FMW6Mfsy9N8NagZio2XBp26Y9Z0Liqg6ilpkuxqyLKIqzg4m/NSzYqC/4Mqzk
gS8rM9dkO1ifJ/C5Ph8ubX6IximELFuBPu7UN31qZL6Smbj7VI7doHPbSOcfktq2fZzPHOG/uJ+j
MZnw4iLVHPdwLNVzXzTDvuf4/xHEVS3T8/OECwLHH4S09bjlajJdSfdxG/6yeo+e+ZGie3ew2bvt
UKaHAydaMh7A69JIvWLVwv9UwNZyvU4SRXSOUbKdPMTBS5CxdcYydccRBpiiZFh6OVf4xe3Fwshg
e9ViyNbt3mfx4J/Wvt5F2c5tS55RKBiCUUq7B3WKHOHiZc5QrZy6kc/yecwGvZ6nWdR3qQwYG86Y
OqPkUhajJ8Rm7gwJNo0fD5SBrhoSrKu+GjFjPPnrwno2eFTU//A9HS/RvZkbv3xPaxPEnxVWC28r
T+QXmlMcZqdsdzAaXpJ6m8sBVqN/d0Q0FQZU4ilM8Jqpi1HWKu0KHD502atmxQCPP6czkAx/VQh0
9hUa/MzKMp2pW1/1oNUaSjCywasySg9JkQQwj8n8xLJpTZ4QZhu9G79KyGUUOgNZ0L0zVr6hM4af
yGwHZAgigQrZtKJoopFHcI0CtJqyUqddgHlXyMK93ij5mCj3eii2JmqSukyWIYpF7hpMAvz2cRqt
ZUS3braIHF/r5d5va4PAllCjkp1Bd5E2qaZN1cN/0gxyrSx2BHuR+BLzTebFytoClE8oGz/sc55O
sm9zF/F/0XUdXHETtLtDu3z0lMXxeZf/EnkKsUVj9IZD1vERvWtk9+rQiEVZ82xMtpTlfoCx4plb
zfT9vo2UXlakkM4ILoelis6DcqBbpgPMBPuBdB873jnYYiYZXABn3KQ1obkYbY/rERjBDW//pZam
cGas5DqzsqOKJuVoyfZuVhmdBaCrx27eo6iMNvw3sHf65TFVPZxC45t7rBV+m0qbgYQKe1SEZaBX
R/fltdl4/2MWzG45/MwytGsAMkMegy3ac4LZwj575Wm6gYbohi/aTHQFtA7JiR+3I99Uxp/lghYL
JQls6GK0hWeDkxZStCPFCN9qnyY64oTf6oPemN6Nt9hdU1z0iNIB0J0dVwtrjYKHI6D6XpcLIwEF
yjYi6HuXroCKejw3w6LKmB3TZaKsPgtVrzeNwQEl46UvBtez+zgGYBProUHBBmGcTOsR7vcHqcQ0
xjk8+WwhE7oWyDzsz8uSDu/TMuHQgrNY2dQiruBFxVEidCKncv01hsyiLUtROAW03Ec7kUo3ODPm
RByFDXzNZY8o050C8EAY+RvVS8CSg/AdB0VdRcBPEjyDqD4FS0Z0TH247tH2iXBOjqpRoWFzAp/H
9HYr4m2q8fxVEk+Fs8HfIt0+QReQzt/e8/jn0OL4SE20vLf9tBY+HfkT4tuanw1t6ivCFuubRvoO
54mfchp5XrgmVtVuKNxbYu5UBdU4yiad+eiCSeO53H2Dkg6BGOG/eW9kPtSQTzfQibxiagxsE6fq
JBFafLEDikAI77YjLVjkapj2oW3eoT06Q+PFb6GY7oec4Wg4q37hyNelNOhqq1PpYF/Ftj+pH1EA
o7lNn7ztDdp/sQ1fEE+Sy5RG+0uKwc9zr8RiMfJw4KEpw0rVeFK11A+f3bLK25nz6YfahgQrPzEg
UziQZI3FcPJMwXe7GdILa5SrjoxioY+uu7Rm3I9iz8J6cpG3Oie+1l+qdeaxyaj63a+W58kSOVdR
HfdvbVdv+8m6ZuI3hvT2ZFzgcxmnbfeDKTU8D2nLPup4MN/Ic4sQLcVRmGVS/jz6KKL3CC7Qj8vY
1dc10VmUb3CeKDGYjhpgt3N/NiCBPgLOQX/hB2CustGqPjesRuJhOrREF4ep90udxUpXPYmiNRfE
NnE59D0DuDUt+wjoqJm70uL6quqj3uP3yW24l3PT7uQ2TsUR3hIWYLmfsSUyVYs+ZqrQradpPh2Z
fqCHUPc05nZGeKtoASK5/ZOQ3b1z6A3ueQSzN7w7tIhoKxfgCbgnoyoIOf6Aixo8PscZUSfftWns
UBDUUA+qSTYOSWlAlLiwx/SkYpSY4Wjmm31OkPjVxdKrB7Bhg304UP6qyoZUPSJWpsvKQyHDF58e
9UUhcdV/cL6JK3R+/Snh0fhdBzIewDzX+gbaXi3yDrUqK7A6GlW0BOllRQLR+SMVK7bRuvwLMhMx
gwlAO0YrOyUbE2M+iiyDMewkBoc5zob6aytw+1XOUf/PlHwwqCAde9aJn/h9NAb5lwjT6YIj2go9
HkKM38mQCqxiMACkgiAGZYrAW+2rVu7hP9R40y/EvtVfvR8py2MZqaTga4rSWM/dAjX4hi6z2Jds
mbFZJvLb9Ov8gEMh/hi9Xr9G0HJPq8TwYE6IxZqM1iPcr2vGb1at9CdvA/uDkk386ogT6MlUt0S3
O9zPv3WN+i1PhnRvSoU66WE5Jn0U6Uaz21hNCQ7zMCUvNqB6ywnWv86PpVW3CSoQXfimS6ZTvU1H
d1JTuvRXHvfuxsf/IBCBfyzL8Su6gLrTAdRovW4LikkI8Qsp3WlbKjZDaJxgyIAV84oMwofAiIVX
qBgwkPY0bQInm0xx/j0dx1xHvzdUdTds3EJlYW7Hy4NsQFzhfWSzCgKP8AM2iXDRJ+kmGaJoapU9
H+BaL0A80JvhUCQ1gCHZ9nc+EOIL0e0RlLke54XuPU9+aTVkj0ey9a99DFex8hChHosUiT9jGXw9
HTOug23yP1qeHp8hwIhtI3JKq2h33QtFDPl/Ue/EuR9lMLezpyj/mE/tdNlXY974YehSEvSzzyvM
NL+aw7b2AondMRfjBmjvxB3GNjEQ0br3FnLoRwxfdQ+DwNROVbNejxUwC74UHXoQdaOAys8X/ER2
k0Bi1J2piHlTpnzs8Z6I8arYJBmHinNojAtNhEbPAc1HKMOY0uds3fFC8bu1z4XujkfioF3Oe1wW
CPOgG66sHmaZ3e2qmvXDsGkac7+34DO4T+WZpGMAgLLvKMLTaYUKeTF2FQBnlS41EpmPytBN9Tfm
aLFTLaQayRXPTfGK0dBcTQaGb+1CTK4JHt1HNK+A3lsUJvcZxWTCqSbDtF+FtX167bJU/B7nfrFP
ghtEsM/26LAhcLNxfwV4oG01CgBklyPaFl6ks5O3td52TJYgpwSwNl+W+BG11x7QJSxBF3LZiEEL
1yxrWXv67/5N6j7LLioo+ys1RA/PWYh19Cz2ONkLFOj9do6mAR7tdhfx07x0zYcNBxppZnbAmbB0
seBW4jT+bLVABQIr60lVcRggwibjSOf7lKQsoKddyFYab8Tj0ETLnzHMBg5dts8qdHgAVjDaM7QI
gtLtB1saWopjbhIs9X3RZcdRGYxozPqTzFZ9HjFuKXJrWPR5LELcA5GQ/LxTv1//BVc2n3QYycsy
KodeaKzd3UBm55+EpuQKCPJJtyt9jBFGeQNnODzZfu8xWzkmtQDY2DlNz920QbLamVm9D1m7NzmJ
6XJ1PDRpkZhNnY8EDva/AwIJKuKnEQV+v94NaZOiS1+3zpdsY4qcIxEPv/wwJVmJqnfsoV3v5+Hs
98XiSp7RmOWDTWTVA6jMctfHCAhZUj3cJ7FsQj6hsnR5Sl140R0MH3C6rO7cx+3xV9MZrHCrYfD6
MCTLGKosw7jvDfM4+oHySlQXzHTTP8+gCMUaSTwMR/LATKrLjR/9UiFdPmsulhPJC6Cj1J1gx+TW
siPcZMWqMMjPp5WD89j53ufcALHJY7LiRKVplz0wGW1FlErzuVFrF/QYhiynhoy9QCrkhpqH7OrE
ky5r8ihDFgo6B5jw5Ur3LlyPbth92fW7lnnbIsOwdB4SNli4D/YqZsofgVuzsmmpepB1inWSGPHG
QwK8SqLNzWF9Ubs3FYWJ5XbLWpR6Tfb/WK60sSUD3fjvq0AEkq/ZrHy+xjScadcdJHcTbauNMfde
zzqcknVG068nB55lycaXeez3/xiZGSbrHQiEYh1RclezMTgJMBopyZOGu/xrexwWHlz1YF8iizim
By8RJ4NmfYXRRw9qYq9YHW1ARyFRHs49YpZpgY0nunwa4B6fg0rbX3rl97kEpo97IJmB/+VhIEO4
EtWKD5Vp230fdFibHO0l0AIy9HhIHXJyb+uRNknRdWkHPW6to+PJc1Xb89hHi0eFHLI7aPXDUz3D
PK3inZGyNBCthXITmT2KsfbqZcNkx1Ls8Fh4BbM2fg2x2BGa0sTNhbVxc8Y9j5tJeXfjgIthyAld
4z9mYdGPZsWaglnd3rJb7Vc93exG8AGEGnCGy6wyt1Vts7cfHmB3pfra/F5TvrzDEnb/u6OxuQEA
j1VH9+0V7k2YFWwxrCNPtvbp44zW5oqtZdZyp6lvi27EwBK6m1ZQWBfRaHqN+zTwM3d9O1z/SeT3
AuTA+tCl0AXcgsDqsv/27YjBxo2ovnFgjO5rGMb9czx0ok4rWeLXRoEdU8bHVygX+O28xjUCRgc2
nbejNqjQQcZ8BT5iFSi5xZDP0EGAGOYefW+NpFbGAfwtmBV5lev6mNQsLR1L7XJBgdDnTbJr1BQ+
/M36bVrukbbaJVXH1XFrU55cpafjXVgdO2siET4MWE4zYL5IUyoR6btde7xoAKTw0b06MeGCQzVn
ptxt6QjYAXApQhwxKHGGvD75qz1IlXyJQM4E0yzfC+Z/DI76xea9MvXb3vpNYHlNoi9VNC44eFYf
7lm0mW+XZiiCGRzfGbIUUrAsQpn1fgid7y99kPbHFmmQnBga+7nhasNlPB0GAOaWggj2srupXRa/
7BGFQ6KOSLUMSV/FBFxZgzMGBx1FZUilFhVNiLo5hrk7rRT/fEyCPk2mB+aXWVwyDiRP3gmpT4CF
B5WvYjG+nIGsvViboRODzSao95HU94PpUfIudgsfS2N9WY+M4VaJWpcPMjlOtYHDHzgrVRf9kiWX
VXTLm9jmuS3CiDMEEyfifnViuNC97lJwO4Y/ogMD3w3SrOhaNgIEqBV9n1qznIJT6hnKAVkGLtZy
G9j6a46mvUxAOb94EbWPDnEpBWDO/qJFHb1ht0MuSuChnwMNi89zPZJqnQAg4C5U55bOFjvI1GhL
JALRCucM9qU7OpRwO+Y9+Ko/4thj/JLJHq2bmR9GB72nrFH3FjGorUsyAQMgozL3M+2SHJDohpYz
wCxxG9MxR8IVPJezlJa78y8LVCFlQjFKxTbBLq6vt0sag4ztun2/Q7OxnzbsiKeFReYCSRK7tm0v
TyFyxxmuI+1daFlWdb757DDKVuBHMZQ1jLXJ594ianXvzV722ZY92YaRt9X0SQlikjwC1G0fBuPi
Tyx2Wh6p7gtKl7out56A5VCJynuqSV53R13Vdmk+qAJmSB1Rl8nEuhTqmHCKR9EH5GY1AE3zEe/c
nRGbKk+LhB4L6yL9KzB6OOvqQByPKhuEZD9rYcIJiDRo0XrbSjqK+SzCLqLc1MsfWO0Bmmnm4+r7
9C8K7i+vVv6CMV0EJMNW4GFrwFmtwOlfiSLiDNo3KU20ZVeZjdHDtPoPPvRDZb0Gu6LqDAmfoPbQ
gjS4LRuRvgJZmM4ArewNYRhag+jQ4yLfm68kDf0FOCR/bsfwOonWvLWEI5ZtRg2ACaWphj2btbdw
TpUvcWtEeYzAI04Rz1xu9Zgled/vLt+DIGXdxZ+YK5vwPBdWHtnooF/ROxdVh6ndsYCSpcuzlS1r
oaGe0LjsMbpQegtZk9+Cetoi8540cBH70GtHNziFCtLxtFLIdixmfWhHz2uYcRFaHoGPefJ7Q9Sd
m6eERqedY7QKqFQI6mDYAI4tv5Yj27oLyrZ9+wEotelBVu1jmv3U05J+Mrv3+pHoTfiqj+U+fpud
HsHm22rZUOpJ++T+yGCn/CGNJ/0NHjfG1VkCJQFo7nHQjwms4undMTpbpmpxya+dxoe/SWzsQDfS
sGr/kmGkbMS1t8S4JUnr4/VnNo/af8lo5X7Pu8HEI+S8+ANUGzC8XHO4T8+6mNNGAdPd4+y/ObSo
oVMh1QPoTxtX49LV/59GbKpEhPCq19m4fJ3kGFX14pu9AKgrUFqmAdJx3IgImYWGdOgT/bF7m4Lz
qqOUtw9G1f4NDeWAGqnFceMK0x77G4E3+PicGbnqE4ytYlJkrR/uAaokkDPY2g7fC9R73evQsL17
iWH4PxaZwcW/If1jHZvcYLM2d/00eFdkMRw20XeCxkpzXMtd99iFcOBJqwNobW53ANZFu8YjqAaa
QjJzk2U03e8w71mr3yHqd/mIaouYt31lx5Afczqsb6bzWExJAuoprui+Ju8gXmX8ZAGyqG8N+7/v
WUCJDYs5CNVNuTAi0c32QBiu/TjHtADSdERPKH2Cqiapo9dsxSqB/21qtScQJhhha8RmM4bw7Gg2
HRLdggFuHNgCZ+dCajlvP4IGOVOaCaqnKBc9hL7Q0vZhc6B9SU3m73gdoOCrwOf1KbvbWo24oInX
kD7g3g9jheziaP5tWdStXxkgJZnAOG/ckNSdzPBy3QqPax2YMq4nA/Jv2gb1izYRGHH4g1AZXd2g
J+nKZoDc7KZNIDmyIOMRNnCf7czFF+h9xv06jdHk+lJMTrYP0zZu2VnoRg7+ivgohbIIobvHf+ky
O1WshGJaVnUzmKbSObjg/tSAtujzhkiEwZfbJGZewywD8evwTY0P9oAgj2wGaZ1AoUFSPKElZzUE
A0MeRWq7m2IqqLtFT4puN+8SmKX9ZTtjbDrRhZsD8h/dA7K4xWCv6sfTZhZgYDNRvL334MPaTxBY
3fFrwoHFvps4EBCT3LSrIReCMdDUoVYQ0MqB27L47mVInJFxdcS869A76RAFOJgecQS04ezwMlV7
xXmCBg4xd31y/CZqEUNJpyCNfQFZsK/9gySJcKSE+4g//vBY8e2jFbO2YLh33v7ZgAjM/mQoVfo0
SLP5oZgSdvh7dYDAht80x1TxBnjAnY9/s/Mvw4GsQRDwS/AF+FCFzgh2kgRDoQ3mE3I4JybfwPut
qLD7WrmUMuzjPVTpbXcfM7Rm/Ql3qZBI/p0Z+pOd4pzAk3bt8AebuUnvSUiMz/1K1/QUN0Fj91tE
tBZLPEn4j4TsW2liPhbUP1sAz6WZnAokZ2ZOnYdUHe1LzSdc1wdBjBUOE95cQW459sNKM9ePK2mX
cB/9j6PzWI4cV6LoFzGCDjRbsrxUJduSWhtGu6EnAdCCX/9Ovd1EdI9aUpFAZt5zb0ro1AtBFWxP
ywbd7mDWxZ5N84LaZFbR3yKu6jhZvUrxiuaUFZSMarQ+Ws7sfs/P30z7EjS6wT8feXsnsLfplvkM
dH6JfAvkN8SX+1d56xYxWkBAZay9RP6jQKSm50Da8I5ZoAGunD5uXiNZxmwQWwM7CHZzY7uaOAG/
+SqAbKanmPbCpAijoboWPauHD8bj/d3LGBE48aZ1k26qCpItPpZ+XLx97NjrkNA/bE+m75etT2YM
HltaVcxfny2oF3FAYmYxS+UZYShIVvWgXDWtaZY1WXEiM65AlSwM+3J4eXBz9u76qnJr8T/tJbDX
XzbrrZ2dmWjIGY7O5mN1nVlTHBPb+HN24v44LhBrXh6E59gbGfsJ2NLUrRsW/ESuzavEIKPiRS9D
JtgxWzTSmHts2/U9FEAitiIkQp8HwH3PasGUSDZWQwJ91TwPfqSCp4Fql6KlGKcVtbBqL3Vdhts5
wON+Bl8P/oh4tYs9wIb95Qbh/JbzyRI9uChDZmsbQIOGtn7VMALh34DZ/O8s4205rXW3dDtyEJgM
hjal4DlEffcvQAnzi1/6hiF/20UsWxL2fFtqq6ofqrroqTa8dvrly9hbb/Yay2+0vPVvm4VtncYy
K/ykn3wfVS/HJ2JBr6ZLnM1RWs1V0XJxsEmFMSP/OVEJIzXxYeVJuVnNVTZRsO/ydj6KKFwrsuYX
xhD2/UXu3Rg1xEj9XSzjhucKOZ27YpZ5yCjUrT/cYe7/NQiFf0lA7re3zRfq21jYDl4qViFlD1rX
FhnDxprjQ4ZCrveAk5vcxd3QUpgsXtHdhCEOLe1KhigHPF+V9RrAd2D22mr9G0nuzhnfx/VDsq79
xER/LSSSXZ3bOkOJySsvXcoJAk4YL+5Z4RV5NReqsLMnBrh4vRJ413r4j91SubMvQFkotux4iutd
J0zrHC2pLffL7rNeffBWhcvd/8CAa1EsEH2KGWPrhA+uDf8Nsax/l06vHJ6hbSoO5HDK4AGGjKu6
HPB9BXGtwnSzHPcEoFQNeCsZLIxDL1/mwFUMNzWoQvmcu72fvzKoCl4Zwdb532Cgp7Cnav7qyW58
wWK6dqkTcD5gmZoGzn5raqzXnLPrxc/WPEzDcBbRPliLGuw0VJZfPiyN9JrP2pcdx2VeWOK00ICF
pzhiZHQIA8YjBwivctrl9gKi0poI747IFYxP2FS2eVP86aoT9s34nEuh30Vm2LN9gLgNL8+V+96u
DHfXY+O2m7erMe495yNbBPY+VBLP1dYubVqwpJbx7OLGgCsJwfBh/1SYusi+G9FU4pGB0JxFaSCz
yE8YIm1q76kgFNcopzR+YjeVPrd96fmI0FpxLk1VPFzGyCzvctgUy4aFOxRJrFpUhx6J89iaKT+H
LSf9aTbTsLCMEYAPgYNz6EGage3n4KN2/dZzKwG1d77hx8slg8ovsU29v19i6fNtzMusd8tW8lME
JQmowZR1b/G6hO92HMSfruJJTlnnZlv/mVUW/Lfosn/u6OnvyJ7D/rCiYM1Jkck13zcbo+PUoiwL
/ricfVaRTDEpI6/REohtP7fFoD58nP3WoSHbJPvbUWaEn5sU84vO3ebBotR5HWSkYFBqzefVZMKg
MUxTmNiWXw0MjkMz8NRPTaeKZ191jf00O3Coj002Wo+yhWjh5uzMTbJk3oXOrur6psYCTQXyE8NV
WzTNXoRWQQ5AM24CtdzJvfcObu7cO2OQP3etLtKFLiGRNNNzsoggPukOvnPuLPXF+qAhTprcLZ6k
Q/TOs+BULHZbNfY/6UxyAADlU3X1DHG6a902mp1jbDRq4JbqqkjtyF85xDo3JhbGW13OqKjYfgbG
6VOw5WG64/LuczMMdv7SzpXu3yIWelZnXTTqXvvzqiSb8RgvmdkTr2swlrDXLoDfsaD6b8ckzMwG
+8Ks8o2OJO73SrvzzXc7cc1lps4x9QKgRWy53itEy+rvaLaG4WNrXPDKcAna5r2Umd3ty3yF2HHQ
YJgILtmQ32z2jj7Vjt0JFIZ6qA/5krXRqZOzKB+B+CoGxLMas/+QFKrxp4ob2b9n7IgWCYXUyCew
tcM1YyDrH2Dgx4jR4zzxh8PYq6MGlC+4iNCYTnE/zsu5gex9rSa3dg/SlVmzQxo2+bOzZUjdhQWM
eWsRwwiYaR1688TrXXt53ayJx17W+TjikuDmE1cEbn6IrnQBFSveKpzyYgiSLttGdfWIzG9Pfr0V
GwLLCMvJjHw7Dr3VHhoYn7NaOCqSCr/FnFKojreBndcXHRHJ0/V9/hKHQ38ZZ5fturEVQANZBnpK
o7WIvWC76TVH/0r7yWKTptKZ531RUZggDS2/987+Jrb/Kslb9L5sTXltVld9D1hO8qTq2XCW0q4v
5jqOcQBfwdUxpgixkH/S2E71MKEOLftWWcN5IeWQb1P14bPI7lG41uRNN9PI8reOA3kM19HGnzR6
q30C4Rf6EC9bSLrgRpGcdvcpz4VZZsYcJyu2o89C0/lfFAsRpv68OF06lWN3BkPQr6q3/IJ60/gm
3omeqysFA1uK53naoBB4E0datdD+D3SiTduxd+s9/7jykRtU4D14ypLxeWiVbnbYwdhvl9X04H94
qqfvfDPjHs4LO4IfZL3eS6elt/eb1p0Pbj5ICkJrfRJqjg5VXtUmnaeJSLDR4bDa9coej2ob+r9U
WPV+FvXyKHynPeCYnHYr5d3jlDPX7PEcfC9xX/FAypogpE32O38Y22enymR7bEpTPyGNtKfCWdsn
ZZXenrPMRXNczXzQ1EJJFW/xScjKPPNbHqc9JWEjoUkCe0zpcKFLPZkfphy94EVy2Wg+QFY9v9kr
O4L8WE47kArCXNd8Alb1dQzR3dehZiy4LdwXw+CjifT66ost/ymkv7o/Ku2Mjn9ccBG5X1pXJUsH
qqV5dAdbvLlFEH1mkG95iscom5PIQiQOMa8OiW4r998KHbUldjwv10L0y6nxaiCYdkOg7fR9bEB6
+gMB6lHO7157f7y+DvoD4ireAeTtpk3njmj6c77BT7SOm8uTnYnYoyRwSayyc/+RT4wyYNUZYFXt
KHKNbf+WsfmY10v61ngQuHOe1sKMV77IF9gWwSYEEWxveA8xtdaRrp00Kyb7tAloo33e1Fafani5
jVQm7opoG/JzvlhrImm/TuDjw1tfay9jphTM5jWMOgYNG8l8fVLr0DI3gFm4cIo+60cwe8jhi57v
d/3WHx1XROMRocus+44r0f5n29N9SwOkU50ymIAxXDyv2XYjfa55Yi4MrMbBooTcW5vTLqRNO9wV
G8ae/rjanW/tFOpo8Yq4xN6kyYppLBLEPUVhWdmxFV+yqsg0sE9DdxRDHImHcJxQSA0X9IljEDBr
7GRGg7n08zP9vP8rlkOA5cifi5XF0X7+EQC3XezQUs+CNC9/72+6d26Um1O2c3oQ+U+7rC3GgrYV
7cNlpVrmoY1OimeCuo0Cu0gF7SOymMO+sB2mrskkbRj0+nnrliJjmLc6isn3kGcQHbC1b1Qq88T/
W+ZYMpq+eyemNLQui6Tj2w+xo374fr/uOFDyd/ZHUNoSrFdSfpdbHLCiDUmqSOC0OQgYJ3KK24gA
N9LxKLpQ5ec9n7Hzy6Yx2ReTL8SBqxJWIQcbQvOqqaQTvdSQJ4uBsL3OFKxBym26Do+E0avq4ACB
mGdnUoODaML6m8P9HGbvDbKkHSWigWJI8ZI4xT7fqiB4Xla84YkM5Bo8xa0ItydAvmI5w0XcNxfY
vFXXile1vcyhGPyTyWVJ72evi3+M+8wp/rlYDsgLtEpGHQWC65LYdRb9jPvID57Zsjv4vNRW4eI0
6pt8FxQ2K+umNauDdORQ6FItR2wmiYJ9Uy9m5O7l6M8bIKyUtEa7SwcuEMSIKRuhOVPjAds+xpPS
AoiWYbb1g787++cV2zGLcb3osdV9n10d7TXZfunW/MObuuIX9jDG3X4hlnCntRGMb2Pfj6YP1Fi/
e2iXENGHMSXYJjirgsv21HCQNh10MmOZcpmrwgDsauh4hkXD8MPFtCMP7RCW9rGLwvlfXsj4UATb
IE+jR7+QsBjVHEKozxx1Zppuqh+n9rDNJtKv3TbVFtBLmbMoIiukLvZz3NV/LET84dYVeTTsfT82
xyC0FpMsfVNYSXV3GVAvt/nBZGWJeQSzchqsQfQXzsx/VZksH4s+RAGNCpfONlpKYJNtG81BU0qs
KS4ZW76j2/Krt/LQZgpP3HOV5M3sZaepl21286zNvrs9x84DKLehxa4+AYXdz34Zyqeu60LDkuBA
vAvJ+lF6dDuqHl2Ba/K6DIgT//I6xOe1dUX4pu8YFwIdGvLFZ6LdHtxKbMhR1rpdeZAcKul62U7D
ILLnZgOtfGtp2J99Ll0YAnx1u0wM6/boVmUdHiJk7m+KLTL13I5TtEzgnLdPexSxxguoIa8j482M
+qfST2p3Ezw4vfo5xKrbaZSff0FuG0oV8uxO1rwUn8UydO+8zQiXInNPEyrvH1WK7W1dRfDodsP2
25RVcyATqXoM7TBgowZMA+oDgGGpqz8EXcgubVxhMF2L9dECzBvSSasV1S/XXy2GBlpTOYW3Fmco
NwR3p2N1Lc7EmhF56I7yZ1wGFnJas30AMa5PG+rjubFCvINtFpf7iij7B2vty5vTzHTGW2Yx/QoV
0Ti0Ym4IYZ5PB+W48xF0ZPyGK7OelqJEYYfEfMBYquI9hrbuL2iUneKYYVo/LNZ7VCz6tTdy/UUq
9/roYFZ5XsP1UvMgHamV1Js9K+4uO9TTEfg8v0Sz1ufecqGrrZoak/gve++I+Q9zCdw4Q1E9QoXh
AnNXh+UtsfgJOCxJ8Vnj+8XYAuWw/bU/b7mwT+7SmWvIKQxw0vaffQ5Ua/GJ/Cnmsv+vawLMLOto
va9QQ6/kGSyP9bxOZx8I5NHzKv23Np51Zti3nPlSdDaU1cU1Cur4MZ/vRN+QOQ0koYPNU1MXN7PU
O06yiMGj0+WIYbbZo5miQgJkC8ZjK8xNXKFN4qLHBZNPgXwlk2mdQcAiSyW0nu2L6wI4isXq9u5Y
Ll/t3DJyZbhVxDsz6+I0FOtIW0xmfaormr7Z88udDFuXK9UGOmUx7UDmjWDCneYNe9oZeekJBjBU
+XWwFCiCzvomtWvn11CH1pkFFdkli9bw52r5HkO5SFzRQMbfprImoA27+licENVlWtxHBJblbM3b
9IARpttlsY72OQGNFzlZ5c6qWHuOLEoQa2SvyUjle3cfOkeP5pUs0vWAQepXCF97Grd4PtHMer8i
JceHYRP9C0NDpq/eQK1Ncl1qyXBukFtsnyOvtI6wsTXWBDs+rJgwCfTMtj+bg9Oswgz+GYyd/p3j
oHlBGsfwvCBUSquZjyxpG7kheYygj/W0Y4DlDqnpwu2D5xdoRfXRjwx9q965s53/Z+rO2iME0LOi
Wd8c3jnE2ymzR6pSu7sOphZOKjzfecstoVakebu9mLyWNNLV6l7pwuyLRPDksiGOGYgZ1YalC+yd
Z84uPgqjx7RWU14mrBjDIh0tVBDuNuxqdwICYqpi3kZrktHBr03zGQU+U1hGcHv6IVi5cB6qZ5gw
pjoMCqyzkXF76j00QNb0YRzijO4SKv96h+du+hN0QfmFP2NA9AgXgsb8+irzon2NBxP0L62Pi6Ao
ZPs1dOypTWJDWktSjH5Eg4MvGkddA1HkjvVN1h4IF2DZsRFVdZnajLE3m+9XNMDVXErp2w84tPXR
Qntp99S+9ftKUQj/h8sNM4bVoDCyiEy40vts+/q7iwKF73icuAinoGIrACEpCJOB56bOAlx9qowG
0i0mFwUa1/aOqmLeBcwUwIem9uhXRvxygfJuA16SnRt13LR8rAG3yEILVKBNpFTFdcpTtn7YQGZT
gjSG/y5gK9BZ2CswuRro0AurKw8LNAS+dvSG8IIf0nvpl0C/5NtmTspp6xl1uZigmpTzHyt42wsW
dRuev7XgDmOfBgwoS8X/FJPVPDF361/qeKyjdf2pvpKAM4YPiLuVwJpPa3gCUTfQTbBFVUKx02XJ
gintRCkYXVWhsz3DYHASLb20ZUnAb3xtCMmQYOPeHtT4I8OD6XwSZRC/rI4B1MhVOTVVEngLHkDM
KNMhbEfn3GpQHSyf08HMOZ6vQrXZlM72GF5Uk5PK18d9t14csgkozUanO47D6pCOa8vtWQQU7XUs
53kXBs32mQVFlrYFuazHmjie77wPhn8UFeJkaKkOm2jsPfaZ/t3dIud982bnn+xxr4gpyriXNiS/
xWvy70LPbgHe4/qPRduNe9JgwYyZ54g6YbcI/2i+EAcbl5ZzgbhYmEOO1vcYY8ZjwBzWP9TS+ud2
LK1fjBj87mRwQD9gLiMktm7L82IrfRW51QF5xr16rK2ZZ4MdQrfC8LPFgtqWN4qRFCm1BR6mYYkT
pl/rf35QDnscB4LvyRbvC8n7ZYLkjS4HvftGBlh2tYFXbrknuyPjNokfSZnDyPjAT6x8lsWe+L3+
be4VzVrVMIopKq+/mbLrf3el1T1bcWCdRKi2dwX9hf+TYdSWjvEkK7wuFZPKIIgP7lQ3L9u2eAeW
bAuGD338L8CfRIDBZt9hbBYFj6QYsRp1jJ89HZWPdWaWjzsSc3NR9n+EoT9/NQXVB36q7a92BmDx
caZ3SGhgmwsjNJN6ehouFvz/y91kiO3F4qFIVWzP13VoMdOM7vansD3vNQS1Pmde1D5X7jb99rS3
eJg3grrntEdqgPRlykrMWo0IQFM3YIFwOAj9cMoO/prNN0g+Qg6JVeuq1B8qhtnAEQFkVB71P6IZ
z+yem8Y85eNUdfuBfYJvgc01UeNv/b1OPmjRGiNE32y8WNWvMnPQmRwDJR4zO/nPhjTc+3pqtn8l
UWSHYfSn6CmaHbii0WqmR53ju7iwOcn+GAbGVPtC2AoEcJRhdS5yGJOeoXA+1rtsqGBwyopovCPO
66h9I2oldvaDKforpLD1w5UMoQ9x56vi0Ico2GkN75gfMBOJv7LIgv5oFE6ZpIi4vwlDclv7o3aC
wDlqdrO5qWn4EAjUmOdNB1B/Ha7sdbKyy2DmNVap5Bogt84IJzMpDd+iHqHsDOsCY42dinFSNQs8
P8Vk6EExSR/8yfIq5gFgNutBj6M4W6FR7neLIJ+OTebMr1yC4fi+LFFenLfeXfwXotW2NamVxZtL
M+c9hOb/ePmQmSfQr6h5bDOrIc2NQroabmJQ1cqyX2CMA0kdIOGrLv1oZ0k1W/3BE4HaAaG7LNHR
oS0lfzXvzWTvTBHay0/g/LtcSKdrYTmSfUSsCSExjw35e95Hh54Uv6PN1j0nY1ObT1kwgS2vMhg8
mIZOLc7ebokSNMdhM/S7yLK1uJKW4i4p0x0FGxkD5c+v61jTBtUB8Eub2b5c00r4g74io0URbpNW
6ByOLIS+S0Te6e1BTrHXvW4a8u7JDmzg7xS74aafvYi+HcpZiPjd7mw9JuvsT+sj0zbzS/QxMEiC
T2Y69AU6Z5zoDJyNgjoUwZxMYEL9yQ+cZecOFoJ9uw3OW4xr/hqsEf4MBoSrh0WiD38wjIw+TbsF
R8RCdfFoHl706r0U7lqdwo7J2aRDP1Wh8H8rxO/vHAfLZVK+vzd+yFhAQlUhtRvnJ3Wexd1Bak2J
9fLZaR0KSQFtKCINjrKMQbsXbU397FbZBEYUN1dTyOidKyI++nLkliprLmI3Go4lVoEv0mc4PZSg
7ElawUQpJIzj4rvr+h9og5NW+o7JDFnnIn8HzXM3R8XzJq2QhQ59dwga+PZhqBrBMDVr/B1Ykvts
NstcmQTWILp3v2HCOvjhp85CUKFCiuKXN0js4F25HrZ1NLu8DeTHqmz4f39ePyFk9I/AtdByGtE5
37HyllPsLfA4FD7TO4mHAx75Uq8pcsrKs9Evy+2+Yver93AWpjSU8cGrI/NQqqn58Bu5fNfEFem0
4K3w0Nj5pzayDB63UIMgOm37MfLG7QRL4lirXU/hCy5V549VsrwHt6X/vrlle63tsMqTVq7TZ2vg
vjHr9EdBl/0Y0beeBgUsnRg8Pl+SvWSvajEa+p+++eBzHNDVYRBnL29RvNtWn393xeJQtQ+Tv6sd
VtE2see8SXuYrf0akVupcwsDTuepp7qsOWwM6QY//bXCe1MGW/6mokFdAMO33dytwV/XspkcMDqL
Uu4PcG01eJcFYe06OK775fnN+tyFEMo2tqFH7QrXgV8fM6AV/Bkvucagih+y2k+BrohdcfPnmG/x
NoTb8B/eSxyXHjkY2mBoxXYawTGMef4QSCLjEq+w1i9GDfo2MupiDNxNO/Iuqo8Rw8SPfHaCHemF
5hDkeYvBHNLWTnQktN43lhu0O6ygw60k/ya44UdgvwyDNsbyr+4yut/VYose2gBsaId1XtsHY/Vb
6tSr897W6IELz8l6sENPzj9RUAPn5AIkyQPhEuMX470vjHcwnx62Q5WwBg+rlgiLaFd3fTDvbVrD
6maPUuTX4t6ipFml1G4wVbelcyYZAXVFKw+dB2F+nDa9HAmEZgo9kY94hyTi+DuIcqs4WPGCaaN3
zXzXff1+Ozn2PID7kX5yk8QVnvyuiA69Dap4yawR6zOY1SsxPFh4jCcpAOKwnLfL2HfeIR5o8ubS
0shjzLhoMMaJI3qirpoiko/asa1PerlzlPf4jYNum4DJV+zXU8q5Nu1m9IeTHJb5d2nwm6xihJNC
kfMcHuqYUZsiWoO1DDO7P61ewZt61fIbooXYKpd5EAUFtNE9UrdSqUNtBmQe1gYja1ZoIk905TCF
7aAfW2oia9bEsBIUtJ2UnKGJaZUufF9woLO5myxsLMxMSeU+C7PmHIATX4hOWh68Al/sWkBbDvbK
feDSIPCEyZ4F8XBAMM5ZvIo/AIHLgAd1VD9mxpt/G66j3wUbPPat67VPeovVp6b93a9mMSlj5u7Y
2SFuzrqSVrczTW69VSKW/0zrtntQexTI2dJ96oYM4cMtuq+RYDDk44TNFHKj1f1tyUX5sWUhargY
A0VZsgE+ZwKUvC4cvS+iGdgrcy14p+BrYBEnYmzk3Mg0rMHRK3EcEEgO3EfZ8xAa8yPu/Q69pqp+
MI6N3qcWZxnoSNm2h3ng9wcggrRWQga8SrLVeNNxbf1baF4O1uBD8OHU/bOJeoNQi3qZhgCTdIYO
c2SgcpSpTudVOlezdbERnnd6sSmBYTEcVoS7rFpmUb3eRS7M7dH2gLjOyJKYX9zVs0rm6D3qFmqD
tndzCMp2nh3dnkiCbV68kukR2V5VSieALyWWoIerlVPdToRY/Zo2F3oqBh0p2cF7qkaXbJoNNeSJ
y9l8sudCv1qKCAf8hjRvnSOxlcVetR7J7YydA23Rlp/rqhMFT7Z2rkxk73QIqs2j4N77ILti1Ac5
DcWI5hm0X/YSbfdacyNxccu1278AvESPIi7H6iOXo0dOjleluum9k/Z8Gf70+2FrOXcw0qVl2cvT
FuBapw0l0WARLK6ot35aXytg5nBXtLa77bzN1sNJdGCRUHlOxJi2sEcf1aIZ3hszVe1hvIf4HEe1
kZVHil2YHwO7mzd6kKBpf7BhYK7Socz1HXSLq/xPs2QlT3KnNPpkSBJW9jYbolPs1BhZ0hh4XUsP
beK19UlmYuT6Zy4r1f43tiGoDApZ3ZzN/atfVGRs68T4wmp32CRWJqNRpLFGjYTC6McgDhz3mwiA
MOTVCzshX+POLvwi9ZlDzJfGX5bwyJ7huGX5Kr+RtOCaDdJidML7cpwl1CcyPLpX5Mn4VUtnfh8X
ubp7HRoINorctb1aYzstDwwiq5eOLZGf2xyYJmUx/FIevKBdskND+tOpl758KLsaUYNZGiomuS7O
ZeXVTItaRR/lqLFx+XSBf0o2mmcXr6dk/1mRshVgNyLLF/jVmF8GMUSxeGgZfuGgIJdwnujbHoSO
s/CIiiOyvYL/vua1U/5acfi9eZbxP0caCqgTGDKcCaIo/ctEUolJNPEw5IrRPkZvSHKLequyPoWw
YobbchjJKH7ICOzYR9WEZTTC67TuCS7EIgOzNb72aCIHd9zsmyHp44o6L8CrQIfGI47EOE8a5pc/
oIIqroE6z6hLiuU/ieh8ZOYhyrSdxHSuMkdMybIQlEdiQ/l3Cph3opJFyy+kneqNmIblKWbsX++U
YPrGD+vLnXF7ccocr+4StHL5MZHud5zDInhoM/JYGpZq/jdJVJxj7iwLx7SFpt3y9W7xGIXusdnG
4eZAy6/7NQA9q2J3qPZFRouGbl5hDI/xUXRx6x0iWHJxAfHi73Ia9faOtNBQwpkAfyTRZlVQbwyo
j97Yid2kMEYQ8kTxyqvtEakjW46oWK2YXUYEt9/FhgEtIZ5gPWoV2qjOmzmvNZIeWkHO9JLWPSG3
e/6lQrkQVVGP8XKeYhMeNO3bQeiqe4InJMgKTKy59BW7olDIl1vT1uoSZFlx6/oqA0gbvR9hazn1
pWpashEmNL5bNKr46FUxgWCWeHfs3pz9zBfI21kdX2oqE6KYzHIKq3UInjuVxcMVsZ9ChpyQKnT7
nTIr2WyxVYTsL9owLCmZPeO0265m4MUcp6g/DIPTErUH+EOUUXvB9+3T33U4NApSmq4laioK+Bg4
3wTvUxtnZdH+y4q7/61Y9Xfuj00a3xOh0k414U/6AGePDLTtSOIYnpgmGQg0J7Pz1LHGydnnXsVI
k1Vi9eMCinvsXeIYbSWGr5WECPtccZlSS05yN0lHnPxl0hJ7RjNGuz6sLdKMmmCP/emzEbi5A0d9
tq50bg7JaWT/bMuxizfxPpX28IcV6/pZB+Qk8W70b/62eW9FQbQe16bNqI69TmGZKIalx9CtK77P
BqwFoTLSAgC9/UMmiHnwhnXZC4dWJ+FlcjhVjecyX7MzIvcMKTc3aNg5TIGwo0s7qxUVg2xRSr9o
1e+xu7YHyiFGDbJeht892V6PJrgHOY2LeRMOOdDpILnR5nCcj0O9yfOw+vHbZnXBE6kx4o2G3npE
U/QfHGw/DNL5oLuLPTLeVQyC6iORI6FNwmfdPHS4UJx07cKwfPSbRv5SWjsnH3CMljNfUZHI8zpi
XOXmNxrnNyuVp2Qrx+VU5GP2EHXZsos49P4IFgq8R0G3MhLpiP/w0At3LJUd06KduZEXg325quKT
y/Yz7INZg2OKtPufg1BYXBRuu0QA3h8RGXj7MjuUZu8z28lPUV+r91C79Q+bJIME16d1cC2J53Ug
rGGngcpkMg9zee4HbPVbZw+vZIqKx8j5P1G0uAqfu8VJCdjg0teOdnerIm+E0BSMzLINz0VRzYRS
sYgGCNvPxoe1Aj/ppBdfGrKLfmim7Dpxka+fchk4j+sULl+Dsv+azSu/nMApXsOxqJ+CoFC73KX3
s+upOYHxBFdgg+HAjrmAXPEokyeJIHJEQqNuJbDwfm6ha0IK599ZQWrefqSvJt61woUEhnrXTXkp
4TR+2o4Rn8swWQfrf8yd2XLcVrZtf6XC7/DBBja6G8f1kC2zYWaySYnUC4KiKPR9j6+/A7TPKTHl
Em/x6UY4HCHTygQB7G6tOcfsZXhNeQGqgGjipaWjU/Yyu4VqCE7sGwuv9WwquG4G3tQjRQ2BH8po
uoOvlMNTo/TerhnrcAlVRWAUyyhqFFewjSN2mUkAXlhuYg1e27ByyBMJIZIEBAl8DcNMy/chi5WP
da8ziopgJ/wo8QzCXtJps1KxDPeg+lFG/SAmS6q5RZEcyHAOOyihScCxh+mQ4ezYCcJo0HqMLuRz
yYlT1GgAPXL9Gpcpp+exOtAjimJmAo1TwZH1FRTALDNjBMnXaFGI0l2N8Hg8dr/Q2Vf2iDT0VkGP
mb38GjD8b/jFYqJA/wAvr70OxZpFNrfmagcH/XEB/OFjH30BkgZ6kljdkGtbbs5jUfXbtFTfQa7/
u6u+CAXlkCasOE7FFj8x/sl1FdcfjLASF/kAikDKFUWlsaXEcVPJ0ZxVapd/EGx+EUviKS6FwjLS
tl7VHDnrfmade4cO/29uieq8fZCDi4oQDau25ewD2cC7UyLcER96kpfx9manIqzS8BRliftV1sMX
i1f9g599geanJYcoTLcaSiIQrvRMbALlg0EtP2Xa63iYNVpEWx8DykIPNB1ek11+7GGqE7D7h6GD
18QODRVuCFtFHIHRCqXgxyIw1Okh//DRSZFDMQmMnKM1bL0HPRzeudvTtf0N3F29GJOlyFRfDa18
ayJUUqg4EXjNNrBeBdCWPxhKpF6MTmlRl0TSx5eI6LueJ0eM84uPvYkXo7OPGjusRJpvY8f+EpXZ
CUHk94999OXYLPQ6SqiTbFlTjypHuKz9UDSWuIy174umpPsaDFuV1Aa7PxlD9KEUBnEZat9ASgUr
4A1bjwDQhRRTFJHjdR96wYVzMTStXKgFdfKeYW/rR6RFxQZ5cvOhRykuo+39CiF+ZTfd1uzaXSW8
tZqFNx95lMK5GJk8ybEoUYBuU/YaZJ09Vlb9wTt+MTJtHVpmLap261ZRsUSVZiytYtA+eMcvhmfQ
CtAQKN22YgjdQ9lzdCXjIfjQqikuI+4jSCeFoSPsriaoQt6YL65rfPDKLwZmSNWj7ErwyoaPTMZR
Ms4GiYzembamu/vztCWci7FZKknOZnKsQbBaNe4FyrWuLz72SC8z7m2n8iMQvwlhSRbOFm9fyuzp
Qy/iZca94lV21HplsUVzhB8ljqxZIaDffezTL8an9HoDXjuYfyZwiCqKdw77sPvQEkSF7O0SROzs
qBlRk29dISbvpsVmNoI79rFLvxihtkB3NVpZtvXS0YYq0x5oWGXzj334xRhNAYaFgvPyFudUNAOj
sxI4wj/44RdDtImrIGlaFrdAje9BIXGKTJv3sq6N14Cxv3nT7Yu1E7+jqg+hwY3BUH6vKeE6k80n
Wu7gBXNCSYVQskndb21ya9z2GQ2IKh33hu0k4wr4ivcJ92+0CQ3aZpZbOZx1plo5Bx00DdU3o0cO
ht6xmeIZyjm6kBu37Pw5QBOkVwpG7HJAwNsgyTUGzdgWA1kIXfts9dQSsPrOOPvbpy51omOsIvVF
5tkfsC4FWwvy2sz3lU3cyLugdI4hcW5N137uB59C1RghQuWoN6Z8bW6lSndvp2m0qk3VW6JBc1ZR
6Uxl4fwmwou1jL1GIJ73241ATWug5yFoYNj1veWtRs551Zm0jCs9LrtshgdS+QYv2yLCxGiRC4Gu
biEIoXjT1zmClD227YyKUwh12Q+OTuG6R+CxS9Wr2sdw0LAD1+ZiIEl5ifllJ+zyYUTbsJFNfFTS
tlpRrlc4n2f9U++wMzDVXUKVoVDd3LoSCvQqDMjUh+xgwmJbooWC0reolZWqR3SYotbC2J7iZpOz
xHf3gdegbs52Io83HFzTu9523bWhQIo38Xwc4PzhAx3Qw7bgM6V2ag391NpGt+IQmOCwtnqsj7XT
z1PaUUvaP83cDJ34cxigQQxqZS3QU50iaHAACw+5A3M4ycLzGCf2nN1ZOqxoBl8B97nPlaGjOoLf
mP3mwontaFgAIz9JLGtzFNSQwcp+uAKyQe5D5Nt7EKYdkpxhr2BMxihqzIXnunObp18oumHRhzX7
tQuG98rUBY6c1FohVqw+UVJEu9PSESUgoxEY/Khz3wNuDjD7QqqbQwFSV2ZHY3GODR3jpqmVO1uv
rJ5OtizAkdPTrnWSC/JiqPeuUx8yXsaJ5Ly0HZiWa7tklwV0qjPmSTtcUWPad1567uphLSK7SZcZ
vRZTOmZ8WyFr2Q+Geh2CbV1WoLXnvuXg7xNwZlugzDusgPW8LtSzQD61UkHG86KFlNwNO4m2NJ7s
tYUJxbSxxUtvTbrEmt7tJIKwuaF5892hlb1ILOAFFjWoTYN/cFHQ5Zx5pp0Q/zIC0W7Ul1GON3VN
RtvJ8awK5n9VAuIS/Z5+7wD8PGUI017VkJzNxNBfDyQHAg4aihEzMa0ymo11q2+9PjYeZNNgGS5t
9Q6Gi7k3uox+J6Dn5HMHGombILs53U9nuIP0dG1Q19DObtaQCpJtIt1U9wH8Y4o+lbpqNOdUKCHN
li7cw79bwPzamDoiGKdvV9UkzMALKpaFUc4aGYU8gmFY24EHTAq4B3AR3un55IPDMNbfRGCzVkkX
bOtI31Fi/2p5rX0QoQbqrC4Z2cOYjw9jEMcwRILAWJOToc2zjnT5tvC3iaqb34kCGeCxwIMmksXB
bWEaVjCuijbQ94ZGk3+hNb26Am5+bQSOZi8A9aPiHFtriQTJVRbpkE87qy++TwIMSKB4btDcfxFu
qoTAjYpPQaBGV6JKaRFijt63o/spDszJTDm2yVFS+llpSbZFsMLYgFTtNFMdK5NIbHGYzIBMMc24
8gpLzhNuYvHJUTjE4e8gPpkmebFQoPshmEVrzp9b9WhAhVn23aAgWsknJaBVKsrSxjp29rEWLu2q
tBZ2VAKWsrySZ+HjRB0CNd1XQ3xEheZek3FyVJjC85QioK4rOBkQnBG808HjYzoQ8PYfhZlfpVF5
xQumHD38bSvX8iGEu/QCekSNWZkgpTEKkHO4YhnObjF+y1NUhFGlR3eoHTWkt533QH0KfJjZB8q8
TBvlWs3QCc+7pqabHjtZ86wgHSlhUKXFvVs2L8g8lR2kSJTFA8+S/kiz9RQAjgOPdFHU1njLrmJc
IeTIxwWCeRSOtMKeW1lyoG5N0gsV7Fpqgl9ukPEXMdQDAcBthNU015bOiBLEd8qUfIPyVHfYVqOa
YEpd1h6qrLLn0cjMdADpO1+oK3pXal0En2NVr7Ntq8h2mNfoVfdh1zrWXHfqx7JCNa2D3d+2SYf4
NKrsgT6NWT814HrmqVOPiJikcY95Hz1VjV2XxnKyAAaE/xKiN14pgE1C2LBpgKBdOUg71mOUefs2
7jatIcotrnkfEkEhT5GlJgvdpHysOOqmIjFqqRug1+dD4p0oPBLnNcqmQ68U6v7KJCGnzRzT2ikw
9osvFjk+86gvvbWRW8DvnPK+9WPxWeWZooJN8CYCb8lkbuRnSGdjs7DpXuoLO9Ssh7h1aKEVqmof
imS8gl4+XEkDpVxPWMq6COkNAFCPnrzIR+kBFTWlNap/B0Jj32YlbdE6Dr7pKj04NKgie2iGVN3l
reM9tGWdLAvc8IuYGRkqS+Zb4YxNTTz3g6bGJBVAiQlj0R6VBs1A4yaw3Kza1uklaff4GcXGQ1v7
fSAm62wV+XBUwoRebWok6OdlL5aOhmVTT2p6SqAxj2Hdjiepjpw86Hcxo3kARmNEJ6u8iq2QzBfU
TjRttb6YJ2pcsmZlOs4FR+AoSfK02nl+D9yNGLPmpsMifJ9RLN/j90nPWAubZW3o3idE3Dk7hCbv
6hUZWsMV6qI+20aCzCxV6L5BNltFP67xUyahMM5mXc7pWRkldifpK0gOnGXgFiRPmIO+6DJ53YGV
pt2OiSfq4rOs3I5gD/eGhooisPqV8VpjKWVjB9lJb/gGdEgI3ILi7LITm6O8TE+DF/LkEkv5M0H2
v577/+O9ZKc/d5vVP/+bPz9nyFgwIdUXf/zn+iU7PCUv1X9Pf+t//6+3f+ef91nCP5f/y5u/wef+
9b2Lp/rpzR+WKa3f4aZ5KYfbl6qJ69dP5wqn//P/9Yf/eHn9lPshf/njN1woaT19mhdk6W9//Wjz
7Y/fNIvd+n/9+Pl//XD6Hf/4Db/O0/NT9tPfeHmq6j9+U0z7d5NcPhuGm23pqjQpsXYvf/7I+R16
g2kih1dtVbVsjr+kMdT+H78J7Xcd1aHqWPzMMEyT00iVNa8/Er87Nj9xTEpiGvUV/bf/ubY3T+df
T+sfaZOcsiCtqz9+k9PJ419Hhumj+QwpVP6tkaRhXxySWRWk4gONWaAbU76NResfohI57Q4/jHoV
4d5e4EpKV3kuaeOP6iOpVeGuBYbszHWCokY2JsVisDPBW1q1+g0A3H4+irzsZhIDFfKDvCrvPOgt
eNtdhxiRMGP/i0EyvkrFXP/etmoAb7SlqpDZ5Kf4CdEdIaWf69oPdiyKAPqVYHykxIFDiF5YZdHh
GhcgCPUrmQmWVbQN7Ja7tonBPHkDrALMNt6qr93mnYPt2wjQ6Xbpuo42T9MsMYXAXJy0ONBCOa/A
5jnA92hs77q+Okuiz2jeJn/ViP+jsXQdPJdZlX2vL0fKm6F1bF9g8pYv/7h+yqt/rHBrPdW8xpd/
5//D0SV0Xu1/P7ruppf+H7usfKF48udwncbk69/6c4Sh4f+dV9cyhUDb7NiSz/tzgAlN/m6qhrQl
y5FlO1Ml/6/xpTMqIZaajqFbuoEhmB/9Nb50/ffpuMzQm0xAFkiP/2R8vbbC/jW+LJvxa7EkMlh1
MtQM9WJ8sSpBEwXxdQqVajjhg43nrPkleodOObjNmF2RhsmWwK7xinsdCislr+OrBC703qzw7rgS
2MLMZVBe06gpFjKqY2yhjuUja1fr7J3aipgu6OKCbdwP0lINMlwwarwt4QDuMy2gLd4p0EblRvew
7Pca0mh0ZZxbmuSh6KV+D2EYm7TisfIXnvnXIvJmDflxVppqUG+vgXmNeZfJjWlTahc3DVQDDiZ6
dSclNOXRHS3tKQFpspFBxM6J5me1kABMPv/wZv01N/74ra85vm+/lgekQa/i3/wzvUk/NlD8oAfh
qlXZiW0LpFHCB9JHSE7aAfFNsCaSwNqPyH7vA/wp7BM5yBClmnOmm7EnjoJV0qf2jVZ37tT39bAA
WuV75ca3+brT66Q5qpg0e5w4DXk5/+DZqgb8pvGpJgd730nU8sykkHZMDQXolVpYAmxbbxC37aOg
eOcGTc/+4gax9liayYJhWyj23t6gSi1D3UI1cfKD8hCquX8voygEQyfEtRIWwdY045StSdGDHJAC
UFahO0yVAXmDgy8Wv76ct3Mx90LXVRqIujAcm2n5cmih7GRIGW519DovfxwcAF6znOizTdA0+aNM
K+PPvc2/fS1f27hvfn9dhwRgM5Y1JgemlLe/f22JBAKT0R0ZqbwBCLXLbZzm0Rw9FOdOpCYLA0s/
LloL34C0cRyh1VVCIIW//tVfo6AvroRXARe6ISxN/anL4hY9IuTc7o++6nv72q4c1JJAGVvX84m2
MFSAKWGFyz1Koj3engCkbeAAf4P+HUNGm02hmw8cvI+/vrCf3k+dSdM0HMYshiL1Mk8+6eAAMHzV
o2V2wVr0bYnBQPeXWpSZjyLLsWg5A8WMbAzeaWH/PHr5atMAYc+32rgaLkYvojo8SCDyjnaVW2f8
bvEsQ+RKvDJZRs+tVoiDrFrrRGWtnnsYGNhCA0GZKRU+kcgnbmNIuw5x8pBdQfut+3dGz/RyXDwy
XhzKV7ppst0SF4V3gCbO5AeUR1Xv6nNT6xZSr6b5AtK/3BPOVx9pBwOPSXnhFwPyrK+/fjSvM/fF
BUz3RreE5DJYFN++vaoZRxCViBihAqB8pipSzAObPF9oJaSXlXWwtgoRXGMO8JFzhYP3qQWZiNpH
OFBZM3TCv76g6YH86nouuj+NXSRt1PnymCTmg0cIonDC77/+ir97KQy2BQxWVTBxXb4UtgAWZYMM
PVolW11KhAB6idbLNilUZErisbcP0ZGvUiopj32UG1fe2BYbjnDRhrp0zJlcivpbhoB1KZzGeeel
fV1S3t4D23bYg9toME2pmRf3wA/rTlJq8U99zoHc5Jh4FujzNx1atJsqJR+aHW+NYwMDHadQ34i8
OXZXyOdOnZ0G3+cQiH6VmIzIiz8NUt5hW4P/YvgVWnH0pDulqo1dStbSs4sR/KaXQDg5rJirIerv
i554VfQTeJJYF5srzBC7ThUUVRqRqAHmjTT5RNgrC91gK9VZVcf6XIzDCIsOQ76HRfXWH0k1dP2A
SyWfbZqDw0EsiDfUrkp400fHS7vnXz/Wn4cSuzm2ZpbBxK/Kn5QO9K9K2dfhSQYdBcuU+psv+/bB
lxp1hThqD37mi9U4IDiRVZW+89T+7uuhO2mWqWnQZIxpYfpBaOE5UN1QUwenSvHR3mMAWAgfDAMo
hPIqh0yDk9ePixULyTOua+30699e/vz9jqqaDvtXXbPhlkyT8A/fP7Su01JEj08qXvRijlwwXRaO
Me1GjLF7poJBYvK0EBI3Ig6UYdPvSJ7xGiAtRQKPaca6yU3wyZlLe2BREwFE8a2pxKElOrXEBTrw
GCVxJVQgqqzY4I0SB6rawdprKIrORNaAu9EZR+MMT115R47C8HlsqhxWeIMpYmEbjj8sAqPnohRA
pgd6KHw165CHs2usy2ielK04NKWr0pDgaH42HP6sMNc8R0MzRRZ4yYMPYwJT3ehuTVAnO/9142WW
qnWD3jV/TIKcz//13f355tqOjR8Uvj9ztH25x2mNSk+70ohOClvwZqbpqnXKhe5tUKWLK+GOw1dM
lgBbdez1yuDJd16uv1naVUuqVKEt3i/e7osu5xhaTm7UWXCCKMnDAHfbPVPOEweVaNIEvptnPNFs
qc6ZU5DvTimVMF4jH/ZYyFLvOkq1xMeANdRn3sf39p8/Hw90ISlosLSzEbLMywmV4HUj6JvaPr6+
YCZvwMHutOpRiDaAdVM6vACg/PVR1juwVco2o9D1zsLx88bPFqpqTEhkVnzzcvjjE8oMtavMYxCz
kr7uvVC0GDtMM2Th6W51/o9fCaGyelCRcSzBHvBivGF1lUkfGUdnVMnd0DN11oogu0uIU+94EZQ5
jA65jJnqtwac1XfeSPG2RjNtdG0haL7Z7G0c/nCxcCulgDyZ28YxUvAPML97VynG0+diwiPRQ1yI
YdpWUPf41GJtutYG+x6sTTMPo8688gBOvSN6+JtllSsyOCKbgnkIuOnbO6JzFs/xvZtHhedzLsOM
jD/8Pd4qpz1Ea8e0vksZWnMf1OmMFvEVQmY6Sb5PYE6PCngpqO187fBgPNPkZQ77jx8Yd4lbzUaL
+Vm7uLycTB7FAwN9BOUOPwCwerapmqR7Dn2NnhVmwufayyBPuXG67PuR6PJfX8DfDBOwqZwQDMEG
3QA8+PYG1T2JioHfGHjXw4G+IT1cjdzGbBiiXWbU9Y64lhH3T+9eBX0fryNT5u8d5V+PyRebC8sS
TMBSk46N0fXtRXAKykzyDIKTYzRbtpnpNf2mek2DyjphXR8fbPpttClouxIfKPuVFtxEBOrt9Mz3
wkVcIlaqtOqp8US66Js0+BY2ojmaisBEiDp8BndJfW/+/ensr0+1GrZCkuGiE+f39qJjo5NKn7O2
V51t7MZktG4aqDo7iImcqy0IsJCRY/vm1w9smlTf3iqKQCymTG5Mu6p5cauqUIdoY4Y6YX56fUaU
VKxpHEGwTsre0pe//jLx8xqjG9Sq2O7xj61dTvGKUfdaitrgOBgty2mQV+0nvOv+zk6q/jlhxzcn
t4ZwSF3xInjoQ7uUVtXumXPPdgBWH8O7UawAgaUL36zAPgmvxCeGNIFuRBJfqYOPH+edq/552tUp
sqEHdIT5N1P/aDhGZ2iVOBY0M6DjNDCKSrYR+6zvuaTUMftwlsOV21kkodxbUn5zpvW5aYT+ve7M
bqtlYATQi+OZr5T4HuZ6/c5U/TdzpU6ZzZZU2kzSAOTFhnq0R0EthovEhIAXr9NDcUitKF1JETdr
LwavOTgOaUptLA6jaLr7lCBuQoqqudEGL4Yq8Tt84MZJQ1KhYPbjFl7sF/nOUSoguI5wklilKlGf
ewFM3w0y6y7kKLwb3KzHWQBDZGJzf6E3z25aae21rYb6HYYffR9mNXukzu6epe9/6La91kp1qVlc
6cX7j8JH1yAHC4peHZbWfIxPRuh+dnAA7kCp9qSw5jGN4CTbqY56m+PlfW5H095wVqiPiudf//qe
/TwL6CaHZSpxkvWWlfftLOCZCAGIaxdHJ+8Y+2mQP+LOZjsU+0S/4d4o73SPm/nrb/2baZuvtaUw
2ICZQP4uJh+H6S0ulVQ7gifzvsJvMSnUthj3wT8tFW3sbsIxNXalk1s3ujYS7P66I/3AVeDXMwl4
ZZDAr337yztR13tKH4pjZMMomVU6EQSNYvrLkIwFIpyzr2oxuk864U7zcPrvaVNX619fxPTA306I
jgonXeOFpcxkvo6zH84YHn3GWMo4O3m9q+3lhFie+QQEEQFLcSmexapDi9uij7pla6S/8yB+nmqY
Y1SbpZu5mLbsxeM367gYYyqKp7IzfdAQvlmfyXtQD1bVwCknSNp/Z8XWftpkSWnoOhPbVFXlSH4x
AvxII+XSbsIbI6DV2/geNLUqzLBDZhnQ56nAR805n7uNqK/JrARCWRj1adIzLK08yR9HzJNLrbRU
1A9OPZN9zB2zxuwau491w/m933Uug94Lxk+vleGI2fD+nad2uY4xzcAE4vBiIGrldHox/QHmsXKj
GZojkfH5HlN5sTPom61kJe+GOuZw7olonyUtYZqQQqPnJirOpRipn3qFl8+YkY2NifdmUQUKJmkS
qPxF25mnbnCS6yxMH0Ikdzb732j8ovaEAfeIQGaebhcQA/XuhVzu4fR6istQyWwcsktue2oJ35zY
LVbExgM/JGm+/5KMmvYZ+ka7iTI4r5Bpe5JKSq4QQcyVNhTKFcZ6d1V0rblIui5dJa3lHF3RZXMI
veaiHmCrtqaSC15M8uUJSyOBxhmCJ8vGHoItMa4lITQRMd7T6SAN1e5kW2RCjGOO4FG39iEZs5CQ
m+YOjhrAWeOoyTFcteTfQi9IlafEYPtReYRhmIChd3Zdi2YdYc6CZ+gHRDvW0XcSkun3Sz3beHWu
wQnr2+yspbm6C92E2mwTjs8TcvMxIKthw8pVTGYu0oQLQ3tP1Hs5biQrn4V0nQKfJejrXpwUaI6m
QyhK9VikBodp3Hg3PViVQygNCEtQGt4pxPzNhEmPTNCOm/psjrgshVhN2WCy08YjxRJ/l2W87mK0
5XMUSHGw3C7b5318GLs4WHTwJZ5GwjXemalea8pvpyquQfKyS2qrzFUXe22rE3nNRKQecekSlkLK
CZWBaXmfgoVJgkkCyq1xFIElH0b/IP1CwIIqshcwWv64MKWRP7redAqpurI+R3pTAUmUGmCl3EDR
Rx/BC0gTLoVZnZO0yzZ5PEgsy4MXByva+uyBszpgVNC3p3Q3tX4mHdd7O2Nu6+XwppDJr8m6IFig
2OhcPN84bUm7aFDRve4koAtR07bgcfowTm5gtYhdmSrGgtDKp7Cx4lteYvuGOFZj1yhMnJlnyHWg
asO+TLU7LyA/rFdAV5JuQxakYYwLr5IkOFedfshq46HUWwox/Ygbu0qsU6BU1Se2zy1p0hnw89f6
RN/r+rEYO2SLrdOFbO2Col1DdCOFWOuHW1y+xYKYFRAq4QizREylDA7TbOaVTDd2DNjo0Grtkiwq
ZdfWYbFtoHDCyK6NZaR26UOReJRgAKcsyQPINplTRjfEp3gsj4J3KzKTb7Ug3PC1IqHwqDamFYgt
WtjifgAm/n2swfDlI8d2LLdwX9idrp2YAMKqV7JPgEGUrznmVyCC0yyv82daB9o0r+VIgxegk/V1
6FvFtRvb/ZriOa8K5XH7pu3SbGPTqrwp8APskhwwC4C8rfQsINPKDSdyufaI9Ino6jbBc2aG9v51
nWjHmlEpcnurF1m4La0qWBuUc/okJPvNguw3YEFZlqNWIOZp+92I832TTpW7sAFOC+RseEktPzqA
SgnWCYnviyiJAenDJt70gVQ+w7x6IezJOWAxBnCqkF25KV1bg/uQPCVR42wpjiurpiYc1g6FfyRU
QgEVNtY4+cFkoK0wTiIOATbmIxpPxQHm04hsA9SoPiegLm6TsGafSoP7kyXIportSvTzkkQ/qtbT
/yTVON1TXDTuSjz5LjqVZWmFJsFrXeDtiNiK/9zRQpnW5q+F6rIembdSRrAPSHyTsIacIg+Msm4g
Q50VhtXfUARvQDRPVfxgOs+/lrmLpuA2vD40veBGupz3vgLYk9e0xawpMhimZEvExIwnV1wNnZiP
XbWrcy/7orvtdQxjbsczJXoRDe+cbbDJook6j0SgahGrLnI5OdT3+dj3CN8NYx8Ylb0to7gHV10C
VCdxPYXrnES71z2rV5AeMoNtTtlVSfV7dlP5tRiiZgPDRNnmcYY/uZPyEGiwOAbK1187YKanFBsM
sfFKuwDETNROCqaNeBzC4FvCDTQrg8hUO3CjELY610Xq3LatPe5TgAsAgmS0gD+srlze5JmqwTCY
59IXj05rl8Q4D0W1aJKc+J16Ss6VUkUqp1s0eYZA8ReCrJO5lpfyc4X35LuFKVTJpbtRI8cmXT4H
AliYkoyj5BOpRhpTqfuUgKG/rXvLeuoa/4E4DLEkSzNZk3BHlaHAlp+XKfTHaVaEU1qf2ayuqGFy
YQHgqK6Hnc9gfBqZnA8IC7VZVbVfAHVqwHAJ0n0mUCIip5v1NYRvSFSA35b6om71p87oqjOHY160
qST8Z/cB/AEvoSrluEnQED4hIKIJMqUh8HtOdQ7LXouCaKPRZb8wwB/auyTark1W/XMRJ+nSGTxy
NhP0+FWjVqew84fVgDT0qCS1t4GVkx9aI012ikA9QXCoMhA5JKckW9SSA9DJJFx5pV3g6lbdg5ub
Pt0zi+klCI2eJJPh1tWcYtupZv6Y+wUTYd3TSZnnvNfLsTPp6euIsDdVGRaPfqHzO7+2rF7vXgxz
7DQ25RbgZPLsFpP9PjH8cI1FP5+pbHco8rTxs5Sa8YAqtPtGLHB2TXykfSSLV7kjxHjYVp1mrMq+
0jeqVXUbEghTElLqajkGwK+yxgJ9M4VzJW6Yz9u6LHAKxPX5tfqSxiMH69GnYfY6lQ3QZc957iDf
lkGsXflJhQoiTC3qBL0BCUNqn8yEWd3RgYoGWNR7VtkRDBa4O6U2sObH8NmzaI98cdwmQ5Gto2KI
9tigeJu9gW8bBpF/kkpDQz0doYWoNhKsqqnB3vTOQ1LL/AVYPIVwCwTEDGqs+piZwW3aacNa6ZIV
uQLtzvZ078qMYrmCpm1f1zrSUUnMwRV2K2LYgC+rsd3NsyCv7watCxfgkcFZisS+TnyM+GaH8K2p
jRt7OpM6DWSr2avUACinyOecG621xnTbJe2dpursnUdnydEVlqUDK6Qd4uzP3i+GCyb/QJFrxadI
GvCo1kDW6bTqnkIAqAUe2fFisKJk+u7pRcaLJnKqdQtwfa4VocfapvgPtp3vTQU2QOd53U7tvGaW
dJl6nyD9WEM9GZ5TTocLDiKeRYpA6Tkz0CPVWSHEcS0bp4A87YpvUu2rzzLLFY9OuQqowxUaXryC
HmkVDlvNkQ11XCtZtwOBFINbRNdloMAHbvtZCYAMqkyjEwwbFZuG7s66aFVl0SXdS2b2/bVwdHsb
0UUj34ktaWzJ4E6LVHMLUpKJTWvdla1p7m2s9HB2gWcd45S8KSHdgqTladQnTP9njiTxsYcyjt5l
EO0XYcbV/WvP+nW7V0Dbuyn0KHkhAweFEGiseVpFRLIrJN5lhgQOE1EJEh2XQyW2L2dyKKyjhaSF
JKgYuKbTDZ/gMStEH6fVMjW08pAxNa8pfmQbi/SKua4WNuxGbuSmgT1hLzS94oTDAP/sNuC8aPQ6
1+3rCokQesKPFJtc16cCNAXifEY2I6N8bBxWs2wEmkNu+DFsp7GssWnziky/baazYuqoyCaMbMkR
qvUWUcydggKHViGkUET6S2A7d4PeEYgNmGvNNkicVcXcpBH5n7x2pAy2sKQQlLWhfZMCwGBXPM2/
nWeaX9S4V/j1seXc9JpgzDgEAj7mbCsoNRCxTD49+TrE31DtKVE5jfyXriuoO037yHRsYdKXUymm
d0ccCYFpN7dhxX8dXZWdMmFUD17l8QY6QMtmjjnKLQcWfxuEwnyG41IfSicCD2dX9riJa6XaBQgq
G4C2VfFVyoKvIyMwoMIwdvfA0Zp7L7eVo50F5qrQx76dgyBLN9lrV1pTLBA3ra5xPaI1B3mSEWfC
5QCOpjmEblcD/4r62y4Njvg1CyB/LV83CwwS+1D6VN/URmkfapp7+4xTpL0wC5rm8M9Ha/NaC46B
g35LK1d5UNn1ZhNBu7rRm7x4yUrI8rPK9+NNSPX+S6tZHXDmtqqDuelpwQbw7ipIjXFfcjmPzDy4
JVrTQFmg29l1MdIpsctc/RJ0qafP08Tvdv2onSs7l7djnJ+w9J2t2HTOoNXtDfNoO3MarGuBUBV2
XSmjLKOdCx1lprHRAOMfKgve9Sqds1/BqW8mAt8ciT6IyPH06FZ+a7hqtEGOMCyLqgSoTAPn0bfy
DsQfwnef9DM4qa65GzN/K0PgsKoWBA+2RdC1CsaGWDNER4OV6XNNK+yF16MPjOqBKF6/BQUEfNBa
hlIvn3s7T7FReOY4LGoAZV/zKiyg3gDdOBDXrKeLutflN94919n0XF94nfm4OOYmgcRXVqJ7D6mZ
GwcPuvn31MnNbqUMgf8Zw4IMPxOxNq0AHPRBjPV6+UDifaXsyYtovWWPQajYW32ifPGD/8vceSRJ
bjRt+ipzAXwGLbYJpCpd3V1NNjewFiREQGtg/59sLjZPJP8Zq0TlZA65GjOakcbqrgACER4e7q9A
3a3SWsS5JiRnESZy/RBBzk3kRM8Q1O/mMe/vdHecnkZbS7GgyOrHNFT/rJOW6xCWLNlrVrgc3pwD
4jsR0Zixqp9gdNkJwWxr95b+MLu55m3GynO+twO5vJ/ZbdzeiaIwv2YR8vdB4vXT89C2Xo9paBTX
3oZKYy32pqWrX7U5K/h97kSRC4S2vrGMJdmPDnWnrOZyMcwi9OshNIFtZdwAFtXAkeDUL/87f8js
GvfSCNfcZ0Tl+udTa/1UkoCWk29p1pfH2uYeq88TWTRywOxvSFRsHZhJbJ3TH0tVTdqD1115VGl5
sl5iDWzjKfeoJDwozbmlnP4oXjDOK4p47HeKQ24AbWTYmQ3i07FtdC9iYWk0aq5Ji3RgYDala0xO
629J2ow/iedYkcurHMcwI4by1gyzkqTALb3fVHRK1WC0TcA3kCCrbz0y+s3GmxL7rz4ZkQw85ZLo
+vMqRdSn94ZdWve23YsgqycQtEWelF9R7dT9CPMWYwtsBvRL4hLrpGG0u/ESh6piP7m8ei87BJ0w
CTtTZXcVm6ryui05inDAmE9YLWbtM3bC3ZthhebO9iK2IZLcfz9GWbX8QqQRT1HSZNZGCcdYcP5B
bBU23x0tLG2niip5qpcaG09qFXRPNAUq+unGSvcN+y+3rnett0yHOY//6gfXQN9omo8cBy9jjfLZ
gMYlNr1eeCA6OG/R2JAoJD2HFK+4Id2NDooIszvMCdOHLCa3wgck+tyWuf7InoVPCDcGCWWz0z7h
NdO98dmZP7JNsW2mGDqtQCV3E+k5ngK46gDuN/BBgH839lb9iEtd9lQXCv8RZd9PlRBttLiMtyie
6Rj7BN7CLcLV8LH0FBdlNLemS+hFavyjSFQmpw2TkLqhnBzHlUusaIcXOkbG/aQY2S6bkwS0IodU
NlrtmzZpNBgcYR/wIZC3k2wIqEFZn9CQOZw+7YJ/KTcYoYZ4CZrc7TGYySEIou03FGiqw2T7Dccc
rqsDOrT+mKI0bmqp/SXHO+PI/Q9VpkWl+CEgx5UgrZ/SGEPUhQzhs5J0HLbEQdZHFCY6RjTcGnJs
U7hus4JTtCOPEeTQjYMDDFFONg3/PlHxIEz9GgjksZYVixjLlCO17vluGss39E1/gGmwntN66WJO
QHNGn5Mr+Tjo/QOOBdi/gAZ47eem+emZofupjWuBtrScMLP2lD9bhz4MZuAAkDbRBJ5rRPv2KZrD
bqvYSzxvFvS5flqJrh7cqcUyxZPF+iqvpx+a0wvqWipp4tyH2a5208QPo2E5mHGGxIjiZNvRncTz
0qQoa2Pc9MepQBNlCpslnCs0UZfamb/+jfVybBzswiEz3ihj/WZm0k1T1Jb4Q2mFG7SdAf7nhIrK
Irf4lU0hTq0Sk1RHXvhakltEpLvsbkTCPZ9qiPHaTdkXIbtcqo2xeaBrta1jxE5BwI6oltSjQjQy
Eopwta0kLHDDUx7/Dkcaot14VOFTzH7snM3YJWgwo3n4Zsvu0l5N9cafwlLddZqoqIAUzWtiziTw
ljI22obKOM1MjGfQ1jS6zt40aJ5b/I2aZAetrWSHYLxc6aGe/zGFLbp1tGtRNSO6mcBaD7plwV9P
3KehJeXbnaqEpysSlY462SROpr2ERmW9NTKdPF3vOI8oFoL/41IKgPkVOTcDf0ZEZB9KVbivI5DQ
t+UUiDF4bt+KML5PMVpNULYGmNUDy7yjVT7cq/Rmnibd7IJpEvyvBeWIsh5+WI0dbo2kVl9UtUHi
PlPENyuZm2MymdvGtqwnimPKpwLYln+q9FUG6DHsI1IYfvhFP45W1XzLzMb2NdCJftZIvVTZ//JC
q7u385FLDbJ8Y42DbIeT6HNxgnTJ0tapIAlIqfwNKbrpzm6jkovYDP+zCqOtUsoSEc7B7SfRpsVT
BsD5dfAG5FymHlUHYLt715GBtXKs74buZPeqPPjiKO6f8M6uNwBxRtwCUpWyyKCdOJs79BJIG4eQ
YJSNZNATzi4vKgZOh7ybYzqVhofi0kzNBrj6UDj9D+ik/dGayyfNWLTA6bvcp7sZkhVpLhq8QDCd
1GLRQXHl+dy5ajd0keInK6FhYsIDsrCYB0fSmoLA38Ft3FoEqRlHFkzccN3I+l+amUYIkM4pb9Oj
tPGzt+gkiBNS8nTOw2nmjHLgUknfJiiaMDYzvoNsE5ce4oylZzlbmGzRa0UI31M9Qtc+VOdPp7UE
IUHblZ5J0aAcijuj95o90ulcxorKPbi1VR3rME+PXj1uqwIddE0d4i+DqL7PSR8/kNCQlKHQ+KB2
y0GYg/6jrczuLZOAWLdCDRmTTn3nNXmMcRo1JC2b5i9C96YvoamKJw+e8t4uDBdx9M5EuHHQdyXu
Mw6X6gcPN6hfrKfk2wCmDR0GVvz1htcFJBLdagdklEuYgWGzqojXmNiVc4m6du102ReK57+QASjv
WoS/aVJZxV1Tqu5+xELlUxIPvw0DpGhNV1zDTzxse/+Gz9UA5veZPYYv15/uYxOVFrKLFrklO6jO
upHbT01PHi+WZ5X16uPJ97s4ddVMM5ZKlaXApxQHuiJQK2RHbwhHXcB7Aw5VTRIa2wUWv4athQil
QwauzechwgZjs3hT9e0UkalSYcyViPoRXa+vY5Gl3CK6yngx0OH+U6hZSYMzT3bXJ2PdmzKghmDk
C74AEN1HYGXSeOPQ4072XOGnRxJa0bdQ5ZVRdagK4lit30CBXZgAx3OhWHqq4Xmq7kiQwbseNun2
kFZ5pDzP2E5ukS2Dkz8lqvdL02f1ea5K85OC5MaeE8p7jBO4+KrOw23Gumvu7MT2vl6fgQuALB4I
bIEEgUA/W+PSdGw24qJblOcFvvurE8bez2ahvouN+bjr2vavbBi8fWS489FZpoVUKHqdO7f6yzPH
UqI81d6f7arG4kVNtxMi4vdqEZPxJon7ZrLhD/3YJzf6axfQSi6rSAX5SEvZ+dBUVAf8OFCTN567
ohfbpa26g1LH1I0QkgjqMfwDqHb3gjZqOGOOmg/bsCiUB3zJUCEuQYagJGtg1l72uBgnmvbSqF1z
gCUvkFkF8uuion4DzaVJnMZ5S5BHhhyjejREPW9N1ClNUcRISlnPjnAyvPlaYzfEptgnsKR2FJSt
+24ku3aj2fo2TciQimj8prkat2J50aGm5O7EPMe3tqRccR+eixMDTCAIX3UNazF0rbK5C5s48LXp
17J0wj34vP6tdUQWJMj1v+ZTGqTNNHGtt707hzYP+jb0qR81VCPuXJkIGVB3ArSn2p89dLDgBGK8
vlA1CRNYPyc3T5tnBD/prBFLkuWE0l+iP4tTh+dUA8P3t/qWkOZveLKBQiQXOKPJvhcJ3mujvlBp
lf2860/yMWi4TJTcKyxBw1lzVsi5OHRUGp6nhq4aD8svzwJTSik3fwolteH6eB+ReYwH7sSDLQL7
UFKy34cMJHFhPQ6Z/myUIUKzbfGTdkyxxyjFBIsCIHHMvAZH6QoBElmquz76hdPMVWmjszp0GN6m
vTrNknoelqxgq02h1j3h8UJFe7bdp97LKGJ3wx0dBvHg5mbiTxNgFGHV9asVe/mmLHLl51RWX1xs
4F7BLP73zPwjMjKEff5Zs4rPmMj/b3zl/5tCwP+HBGXKJNy5iCGEPz6LAczh3UeVcgNncgD/879Y
8b/+x7GV/2rfc5Yv/qK/Ocy69h/JXqaawmEF0NtgiP/mMHv/AdSgEilIbQhlEtDz3xxmW/0Phhwu
MDHb5DiBCvJ/OMyW9x9CNQAQTj7LlsCmf8JhXu1BUIuuBuxAJ49x5RG+WpRoqkALG5Il0MvJ29A4
HA9tZ9+hBzPgBm1Pu3fz9fJ3lHlPw700HFkyMy3BkuCZzrdgRwFWskcovnm4EWMwpW+GLoMiraLa
26b6LXj9asufXk+W5oHkMlsUsc/HE3goe7WVcZPAQCsA/tg9WnPWv1Ann4O5Rcp8E5Zzd/TiLNp5
+qIdrr/v6qw6jY9ZPK/LEziwzlfj532iuVWu4oBc2cgg1fhqpVZ24xRfIUfkKDKE6iAEpAjFh1Ga
CCjuoPERq7EIUljOqAigpg7La95ef6ELE4poBbRt22LFuJLg/z6GNlxhXQMhskBgHHToPHR7MN+D
GDKX2QFGG/abnmdtuxF1e8ol5Y03XQfR06tCnAEULp8AisL5+JjPx33eqCwgKnlbO84bv+67aOvh
3vSC+F3nz+juorLjBWPS5Rt7QIaNBVIc2lLJnll7yUGHxhQoYagcr8/NOpn6++GoVBlEFQeq7ArZ
aLrlAvBrXAKKgdL23M60T6BCaP6JnkiA9Wve7OumT/GvqKv0MTfjJZQLsK/BEdTx58keDZzqhCne
lhHbQT8aENAIMgsTDjwK6uSZukH6U0X57tZOWV1nTs8O+Jt0AOEsFUrB+cROiSvN10MUl7QYLEjt
VPDB2g4axeAnrdNIX8cwaGp9+keqG5z6LF4DAhspCcci0gznA5dmAgfRMZYA6Tw8Mbt5OdbDOAfF
MP3CdOnz9W/0YatI2LEBBwyDaBP4sfz5u2tDyBGLfdOEQwGvsuNumbzmoS2xHFV144ryYe+fEM4Q
piERSh7AKrQmHXfrBuG4IKZAIWAzPbeiG268z4eAyiC6ITNO1SHM6aslt4RItzRxKA3bupACU5s/
0uiq6JU3i78sTn9j/18cz1ThcDCPjLh6KUXr23RooCUNZTgi+0hHZYBMGHiiiQK30Nov17/XOlsF
6c8LkiSS6YN5ddaUPbBMtFptBkxyHKsyvBz8hq5xoJluAkxUfGuHCBi7XXefaeQ3h7xoja1iFeJG
JL/8ICwcIDOGDe5Pzsy7lWPZYz5PrmIG1qIshz5t68coo7gzZiGEQa3K75Qe2eyoReVpsab62Iix
kO2Z8caTyA3xLn9nRiCy2JzbVI8tmRycP4hdVTSGcmEFVZ1XIPJwgIIav3XBdNP8UKuN6PToVtz9
EB7koNCYuWpTkgPAvhoU97oZNz4z0BX0uoQb+hMIRWx4MM62szTeGqNZ7CNFPoMbbdV8IuhxIO+M
eGl9O0zRuhxrNYgd4wkMV3Pv2ZEROJ7V3VgwF2aHNj/cRVQjAHy7q9npa7OwFbBPQd9nn5CsWF4j
I8w/ZZX9DRwnNa46c+MbY344FG0Jx1Wt0+To+vpGhSctEo+qpgaYdtToJ9HBxRkuCUoi6hc1nn6W
CgvFc+twF5llfiPOrGVo5ILwTBllZJ0MuvlqZdp6Gc9F6zK5auswzW79ZuWVCQbcNIMWVUO03BVt
m6B4F+AdhgN9amJ/qoL5Q5zK2uK2q+/6KrdxGeMUF2WFBbOnd+ifjHlwfT9fnCr0fCjdSL2lU1nn
3S6a57Ki3bOoQWpQ1s9HpXlaSlxTtGGoMA9MaCG4ft5mf5Inihv3vwtr2DNhlkuTavKkde4wcGom
48JnsnI3w40XKSmh5xHELP1bpGGmAUKw+EIdZLoRNOXmWO1YD2AvyF5CmWutCYOYZPZ6V9usybER
W9cgNeuLId0iu/r9n08v55st+S0Imax1zr3R9jqK32pAQzTfa3ilHYqw+Lmo5otNvRegzAzMiqL0
/RJXNw7ySzvv/dirZViXVq7VC2NPdHmptVRaQIcME3pNi/eWrid3ob6YNxb/x/OIkxw+KFcrl1qG
JR/q3Xrqe6dNBcXqoKQ1E9RElgfYY8VRFOaA8ENyq4Zw6VNaJrGQhIWB16fA3I42foWOGph54fiO
CMU+FPYPMn9vc/1TXjhweDV5M4QPTYtpHecVxVxK8I1qUOR5FyQiGrCqH9Bja0FgevPS+yCjnP3k
DhA4FQsGEbA1TIJx/LjxJDKJWK9ftouD/5pJ2WQdYOK5N5MU4bRgsKIWSWf92LjVqz4vtFlpJ2/w
NhyPsY5cME44oT83Nd7gDYGmAIJ0Yy9d+uC2Q82dWEdvdZ0uou/c5HbZaxgOZaHfw0bchZgGbmwL
pS0qcOnb9Ze/tKrfjyeDyrsFhpe2WdftoAVJgxe1nmGVGRWVGVR2lRzSmTZSs8zdDaWdS1GSCAtN
FnUz48O11e6H2HEGTQvASHPBMQf3YOczDn0oZFl0kYCwjWDuG+hJWt2J/fVXPp1X6+8t9QxNA/0h
mZ6fv7ObLFLogUUelYUNoMioaCwpYKZHDIyUMIu3VgbeoJA3m8gZm7sOuYgn/tjiZ7k3BtDHq91Q
ZfbRbk1pelalN7b9ugh8OvO4Y8mFQEqmrx+ROnxeFrGuIm3cAhsWloYQK3g6FMSBXpeVi5DogJRt
buL9DgjFp1mDe2obPxuCTrGpd5hYULe5cQW8tDpJOvAjIDpYaNCdzxxEGXTdBLLOhSasPwfQd37m
ZAicoumxw+nTvrEbPh5pOrGB3Az6B4Ipa07jSFlrFtCFgimOQz/r1MpXm2I6hk1eblBFevTswscX
LPp6fYmYHyIC48rkAJ117mzrioMZ6na9lKEWoAmffIo8tfSBtdxi/3zcBoziIRMHM8ajq7Tae+gO
VyDeLC3oif0vbmU7qLkiVB9nZncMxWyDZozzAyaMv9zJdW+kCx+/pRyddJ/cjrTKlj9/t/P7IZWI
W+YWc0CPxNXSAzBs0RuiYAaAzlS5EfA/Hi0UcShqoGNDCsnmPx8PtCT+T3mL/GSXEjqHLDnYY4yf
LLiuG8v00uej3ihvEZThaHicD2WEcCnSmKGAvo6PEelagOdjf2OTXnohS1O5LbIjULhY3U17FHIh
sfe8EHeDrWYhTzbXMyaZmbvcSCsvD4UGFLGATGCdgRvpmIR6zQvRMAOaklcDrr1qF/TglHfXl/6l
ZUFtlvMYKjGBZ/VWbTT0MYgYPRjUZdmNmfgRI8wWJDaUpm4eon8ziR4Jq6dB3uYFzz/VYsPZgZGg
B3WKYHFbc/eU5rM+Zoy3hrqQcdAWIqdB/YV1CFP2fCxdqWoPszOwlzjWBYOLA3nEMb7DQGLxazF5
W8tJgZuj9fqbMuKdVaF27NPEsW689KWNb1Md5nFc6nzrxr++1KIxrEGHEdCL3RiWw5YzZQw0tfkO
qBOTZNdzXmarprMKdueW89jHM596uEZFjs/L7l/XHErFNgbKDbhr5+5wKAvP7/DjxHnzMcUP6pBn
ILKuL6pL65fmAP1jMndu2fLn72JNkeZeAkpAC1B/mrh3IYE7D3g0uHWe3tgql16OT4uuIhYgNnqT
50O5SINpSUjo7kHlHQ11Cre8UI9/bfFqCahJk0T0XX+9S8cUhwQdRyl+9KE1mthItVCkksfFLBFC
SnWn6/GwLw2zeaUFAehSi9W9XYPHuT7ypd3qoTbAGcKrkkmfvy2a4z0U0FQP0kr3/LJv5m0+onjS
IyK2HaLi1h66+CFdednX6FEDHz8fD3nO1BwVZhelohQaV2/tEquId5rDtrr+asaFL8kLce4jkkZZ
Zu2qZoSqPlpFwnbFkuux6upjB7BvYzSJF+S4ym4UrQJ7WRw9MFiPc6V6D43uvqlupexafOo23Gbc
V/sEUeWggyFpK/5iVTtjmdIDnESsxbMSXUkjeQNzbhxUK9bedGWJ76HRiJ3VoQyEXta4D0u8U9vM
oyPQUhVS5nk8Aktxjlg0NfcIWyz+7HSgmA2tvxGOT9KK58mqriFggbQLsABugKugJZJcrSIo2MHQ
GlAcvblHoVos1Avt+jjBBgG92na7ylBM1AENC3/2KNulqQDZ39b1Jq2Nfp9B8/OHZiju6znut3E9
2Dee88LCeP+Y6+7vMBS6WCa2AAQ7EdiV3r5SdikZKlq21xfGhTXPUMBQDOaEBE2um3fBJMz0RlQV
17WRdXrnZsuXRjTia0eLDKP7ZUn++R6jwQlQC+1JOkPrQrcKyA0XS9K0Mtfc11wdu0MbenDQqkjf
L4ve3Fj4F6cSkRr6LGQv5Ezn76dEhet1CBUFbaNFj+mcVb5C9Xg7tPP0L4YiwUWElXsYdd/V6TtY
+B8LvaVyE1rNXVlp0bZvWjhTOq4117/apd38fqhV5Fg4iZy+Ziiqc81BFPbvddYnW6OvUdyzkdUZ
6GbeGPNUDV1vHiqXlHQpXxofpGbbNmxYDyPvl8/54CN6rnyyylYrA7w92v3sxfG+sbOfI4ZcgSVE
cjBCxXtKsrr6vQJTFdf6nynigo/wfbEpzltTUkjhjrPXuhjbpaqaPF8Jy5jiXtVtPaE2gTJ53eiP
DtyyzZKDZPbDENadjwXvoOObUiyFX9eV81VFSonEIw5xcFDqycEeO3cXfHLa8WXykubOg1ux0OMz
+s81KgHo8vaZ8xRxpzB3xZLFz/jNZ9g+R7r93coMJIxmZmEIQLdn9V5zisLaxY4uvYZRyAQLOke5
AGwsum9emIm/tKHsaa30UbWvzcT7zdQpEQZOYc+/o1A8DBvicrOrrB6cqKt0Oj7blp3tvNFqek6A
qgWJqKTdH2Na15/V2dLA0+r8tVbLzKeqcAAgz4n2qetJVjfjEm4pZS3qttCmufA72+jQ5oni9ldk
9SC9Z3IVbJvUeWo3Dvja31xHKbjjNu3wdn0trsFsXK915JVkW4lLtskuO99iud51dYUjeSAWvKz8
dpiwNa9c3ePkHDXtd3QUhOnnukFDW5my9Ck2DBwEabwlv/eh7cJmm/DmCaCDig3gvfZbbFrea7XE
SQXEKBp/1ErrvE1VYv7qDVy2bySQl0IEt0bbtUFmECjkz9+FQJAzkOGHjrIg+tV36HW0+7joy9+X
hW9wfa4uVEt0hOCk8i5ICg7+VTjSY7VAjW1Qg9aDVYJjDKjHPNYPVeQ9tKXTP3d5XviVii0U7GNt
2xiz55uUJgHUmt8H3WsDJeVcGher24d67+2vP+ClwGJxd5AQCDLqtWzz4raTzppRUafJy2AWTeZz
gbJ90PjNJg3F+DBAVL0+5oX6jE7yTI1I1mfAOq2yzBFW5OQMrRYUhqDd3Zrl9ATb8CuKEuL3PIP6
v6mMVLxZbgR0EAXG6A0+4/R1nvPw81hnFgK0adTeuzSibz3chfMReW2k1nVodbg+rTIGCz/ytsgn
qmuK4+ycZP6jrXrTn1w12Xmtpf/z+YeGICXnETT3EHc/X4uEYy3ErJupaDGRzRwcZxx0I2iKxfaL
EE6y0Yv4Fk7jwgbQDXBuYOtw0yDnPh+0WdyhLpxOo0mYRJS7ytZf0FQ7dr1Zb298a3kyrQ4RiXcF
OCAzbVKA87Ecpy75tLwg+JYsiFAJ34Y4om2csdNQudPDwCmRK/fGhYtb7t5Po1rslBrbLactb6mn
X7g6yksb11dEa4C0GucPk7aj14RWRp6FagJbUsGUJI+XOwQJ5k2K5Mj94KZQ3uMRhjSw9hsL/9La
klo5TAWXnQ/BAJNALNpLSkVKXmv7Sk0fzWbag0mP7zJceW6c32uJHhmnAZBpLGbK4UDMVp/Zyxvk
3maKEVOL/BQtJn0jqqVGByZv/SYxsIlCZkEyw742SrjXW3O40RyQH3f18bl5WOwkKgcI2q5WN+K0
eWTSCQgiuX2SMdM3CYynw/U1duGrGmQpRFgL6VzanedfFdIEeoLZqAdWZmuv5azPQRXN/SYbumlH
BbsIhDo0aKgkkr89ZjfSwEvDQ0GgEkBVhHr4anj6KnE2zK0RLAOVrBD4doCoOJWQMJeeZBk+ic7g
+PBLv1Sxo7xcf/mPoCe+Mi9PPQQ/ExLf1fAxLrFq0lPdSkLc56Xuxn0PchtnHi3fdXBXDrLYTglv
crduNmU7yjTgs0OuZ+mIhFxZZQKzc+sT4gbVjam5cLqw5SEVyzowKMLVCkwwITTLyNAxy6yGIF50
MOAclUejpTskjGzYzMty65Z9aVCaE0AFWfnQL1aLbup1MEN2zKKbyccb8WT0xbKDFZ8c4NOj9dLd
WOWnZtt6mcP3cFBIpgPGUjhfgKnpxcOERwu1TMMD41ZAJ1ankgpRUz/ETmzIZpxUlI4x45zxYBgw
QP4ivOZ75qFMgunfrVvQhUgjvW0o1bmINUM7OH8ixEzsvqwrPTCmpPmsOHa/V4bqra0ae6/nkGqv
L8ILBwrXH4+zhLslFgzyEHiXUYmIopGRFUaQaMiNpRVua1pPXmN7vXsjhl76uqx4cmeEmYE0rkJ4
lXZW1tW1EUwQIH11Roy26aUKT6k8Q2CpgHBUw40xL0ZS0LSUUzyqjt665mexxzPE3zFhs7PuPrGw
Bx7iDpHRSUupxSGwXo7Syq1RqCrnS3fES6fYXZ/jiy8upaBPrB7wVedznGJKN6Y9z7BUY73rFkjq
U45DtKrlQRsr+i5fvG//YkhaugBHABmT66+GROp6msyJwLrE3VOhjRl5CVIGHn4bML+tOd50Ixnq
9VEvRjSiGecFp5b34U3Lxkxg6oUsXmGExzoT1VZMvX2P6vWyd+tE24ihdLcGRHHoqfDAdgsoNzwJ
iiaw58Lbqqlpb0fDqX3F4QNdf7xLW4tEhmCrU1qjtHQ+KR3UdbPNYyOAUS62dmP8TNwyCjwrUe7N
dPJuBRc5yevgQnGBDhe5MrqO8vh5t7fwyG3BJeqnj4DqquDSa6ea2IWIbOxhlv6Z2GK6E1EePVei
bI9hTgyqBtTAiwm2lRdGG7K98Xh9Fi7teLafA7/WARu+LrNY1dgXVCDMYDGbX0uoA+9qM/QeHOQd
ro90ad2TrwEAdSh/Y/9w/v6R1yYJggvgN5TIeXDMTFCaXZx9Z055UHeWeh8ZifEvBgVqY/KNwU5R
STofNAWim0RYymBpWYzbeYr2C84FOw9yF01l1Iws98v117w0oeDSMACgMCfbYucjTkg3pUWTgh2I
nMwfa1Pze0ypNqJNlhvR+gImDFCtCkgFrrKETcpnebekEiOOLK0ZDYo2qvGHHQ3Jgbr8fZ9GPUbS
yIONdBy2MXeufePgqztR830oilnduVbfscqzBYyyUh0rgfVdsWgZHUlKyqhu3Yi88q3Xi5/0FXg8
Jm6cLXJzvHtSLnmREFDKsXWdHXrW0Xe8oJHNaRCmCgch7uDUDrhSxNoW8NotHuGFzgS9AXSOyKo4
3k/32HejF6VZ9FEZmaSv87DLuhJYBbIHnyaI03sAkeqjmqdfkO+Y/8XuYk+hQ0V3lSR9dZ7GIyUd
dBIZOLaoCahudO9MCoYdldb9m6FcyjlA0MAdrnsSZmlEcViz0tsQ6SRXRfk8i/V5S3PpVh/rxHL8
8DWlyxrdSkgJ+mrdxW4GFWGiaFYaafukVX0PcLxdtp6i/Yjdon6coHjfqYXz3Wh7i6TJmn0L9uo+
QzQpb/stMljqHuuSKMD9NdtV1Pe0rFExGHZVkEWoIKJJBzbdztVNGYejj8alub2+US/FIxha8v5I
UIIicr4k50bJ4OYPpmyPT7sYevTWKPAbr50a9eAIhYBxQljg+qCXMhBKsdwu0GEHdXByhnm3FA1l
7kXRjkxd3eONSeRCzAVAx+SUSdB06hwYmfm1z+1oX5Zddj+UpXZjL17qABOdANIhzw9Zbn17tkzw
ymrIm8ObEEdwI4bvhOgQDRbuWSjcLC82dPiHEjEmP6nUbl/kXniXJ5FxIxW6ECvPHmQVFWLaZaFw
WLOVMqIYBtL5uXKdb8mUJ7d4m/J0WS1ZOBsQ+lQ6aTCFVl+7NQ1vSkPdDLRoAKXb0dWvrOkvUYzu
DlWobu/0U++rOcZHhq0o/uR5+o0dumYzy3u8qVKDhxVFXwNS2PmKK/MZ+RChmcjSjfOhHszIH/XO
CgpO/401DMvOIE3bjhQaj5lhIPzkeqQAsY6JT46j+vWleCH/4XQiCzY5PqRy9vnTeLEzYyHN02hV
WBwWjdi0zKXyCNBb2TgJdMXr41362PRxZPcI2D4l1PPxkKNUG9R8zSCjvr5xdUUc09jjiGwM8W+G
ojMmG2Q6JLRVfGqRMEM4sDGDBnr6prRiwq41VJupVm59VLlE1+tKwvP/91Bylt/t52JEcS4sWcJp
6eEoiUHFVm/HOrg+d5duprBncasFKsr6XUOxHDd0WnckTZuLuftuU3LyAeWITQtc/dhiwuYrmlag
+mQUe9eYQRco1FmTHoxm22Xx3u1FeiuUyfbAh1enFoQxGxGNlPb81WNY19hE8kGxc7BB5YL/i42K
CoXe1DvdzpufCd7tm24plsexrJDab9p4n46dfiOSy4E+PAigawrzAMa1dR8jNdAtRQaAlVygcR86
uRM0RrhsKcAmR8UgDfs3XwMMvqSrUA5bExwrZKSseoL0U6kvpgFryyqmPyJltPaohLhcH5fiscL1
e5/isLBzMkhoYxN7O+xJxde4GeMbSNKLEyA96CiVkOOusytrBujTlGzlOK1Gum11+kgFI9vYRWpz
fgrrxl3m4ngwdcB88eE/nP9VUlrZUrYs+qVPfC+0l32b1XVQt065s2IHpbrrM75WCD+FTo5p4N+y
ug7E43ytQZqORkVDNTYyF2urQtPxqxkxmkwPX4ciagO7pAaM4rQXICai+1mfgxXtk/x+QZ3j0eqq
6lgUdf7gmtDw3AzAqEAMKxipIm9QCi8OY2zNGz0aDR/bGDxxrTz2i8lwsety6ucMQt8uTgrkAC3n
VnXtUmSkuEoPhfIqG3z1cso8oHlUDkagGlF0l2fFGMBnbXwnqW/lHxcyYeBlkgst293uOiFFuLhI
e3Mx8EvJk0Cnkh3ocWzva4pYQZV1VLFFPB9RPeluhLBLa4bkG2IoNDnS8FUqDI/IcxszNoF5Ou2+
r8r2JbKVctPrKQKiwPlv7IlLb4oPBIUlemJ0B1dngFGpi4WzDolW0U+bbmiMLbaYD4BYuiMS6QLj
OiPelNrc3LDWuvii7waWP393IojBdhLdrNmMrTP7ejLZG71EudVCqnVTJob9z6vmkuYCoE9SXmiG
no+H8g99LhWgBGhd8ZdrFe5dOpPCuss8vtGeFGjfJoWf1E60G6WG0fWteekSKunIQEIw63FoxpyP
rzSNkguuCsGS9t5GDcvkW0jefVdm3nSMC/R4u1bvDvlkhrvR7PRDDb/he4iLwqbNvWinWkNPN6F1
kElSkZaz9egQcYQdhkTc8n281Mbl/gf1lbY3TO11kT3VUpb/XOuUO/T0YA/FL2OquSQ5VruvJYy9
cmhrh3OaAyOb9J3b0eqA9aw+tLrdbMbZSR/HujKe1MhutwM59ucb03npVJW9DzogBg96Kqq9Wz5a
i88QQkh6UNRSIm1aMnOLBOCvZDHmHbIVSwCqwf0ti3BDMBSqzuSa2bOKH8WNU/VSVAJz70nRDumE
tvquaK80c+QBPJum1nwLKRFsUQ5b6OO66tv1l5bJ9/oAfz+U3Mvv3tkSndZNFgQxU6M60AEk9HNF
mEd3CaM7u7ftfT+Y35ZOVXfJTLH03yxh1gN9RJmeApc+H9+JlMVSsMCGoGaMG9g/VuDGNDpyrU8+
L5w49204ir2XW8arwKp5g2lQ84aeb/8ZJfbmruI+j9YmWh9Vh2QqgNkhcBv3q8zk99en6hIeUJYx
6JHBjJFEt/NnRRAYpH5cgvsSkY5qy4w66KhC2kZu+NjDz/mEWW77oFdLQU6WzrgXFPGxchfhT0WI
/GLZ/cr19DN7zbwDCopsManTvTniYUxjbP6uZDaQ+9QO/dw02o0+iu4h7hftWz+bbvC/qDuT5biR
bcv+SlnNkQbA0Q5qAkTfMNhT4gRGiRT63h3d178VyrSqlFIvZXf2apKDFCUwEID78XP23mvRBxlm
tUvNY+ewY/wB1YwZV6eIgeyGsAVv01alONkUXwdbme1GFaYig9sZf1OFfR9G/PzUELZCV5vVRVAY
/HgnuA1WZShUmOzk6i5J8Av7qeGia46jEBuFOA2Ncg8meeRnCrFmw3c6HpdUOgQ3W8uldrNhzdCt
DkTruivVqOW5HR3QUaqptsLJKoPA9/kDPoW5tgf3d+OmX71gmEiMaxmFn/NnCCbtMiIsS1CrEqLQ
itTQbsvQIt8yCOp+sxn+otdBn4MtAqMPPUn3p4O2baWDpwZmi3OZ5xsDXQrMYVXeNE1WBy5gwNWM
5fc3BLBffj4WMrJ/+IAsIj9+P5NOpq6lmF3ZbqE2YrDL53F03wzkWr853f/qSig9rt8ptC3e4B+v
ZJQu5zyNK3XdKPe6Yx1QWJu3uSt+V8X88koM/pkPU/cSM/TjlTDLtFh92T9GmLt7s6zq9TIY0dqE
tPCb5/uXl6KW/x4zoROb8OOllpaOIkI2vjMLSK/jtMWGzE2CiEma/U09/4vHg/KTyTO+Cpb6n5X4
5WzTiI0Y1HR9LPeSaKatbdRdiM4W+3bOmHnWfjsA/MXnI5gKLyllPfXDz85H3+qJFW18c+WMnr9u
YqtAL2UTxVr4v+s+f29I/rRUcBBmzWSJR7L9814GUXb0o5lZz+B31XZ2EDWmyFXWpOc5Zy0V3XrC
Ur4plrm8KZRmhllSkVPvXTMPADKscL70W7h+NKt9qMsGkR4rKgx7s7Sad0K25911CKhRXov6A6YU
rZQiqraMt+Jt2jev/74H/KqKQYfDBJHJsHX9z4+PhtGY6Z/6E6xL9S7FOQGHoY9PXdHFByh7FPUK
jo/bF9mmJQVt60x6frKKsg6jBtuRPmZy1ZWjOPdD5RAx69TP//4r/uLLhftGx13YDFu9nx9eb0iz
Ua95eFUNYJuAdYJ+aSzt8kT7nY/jFx2Yv1/q56MhrUzjag5GID8jsrbcqTuQAxz9Zon5RYnCyI5Z
/DURg1Scn48vY5naklYyahD7mj2eD9seiibaI9dfpw7HUMrw7N6vRLNHFFv+5g391f2kSc0MlzEG
c5Sfdn1dgbx0ZsIUJhI8ualpdlgs+ZXo299hA395JU4TBE8xF6Sh8NOzJQXymqu2Kanj+qEW7rjt
VEKDX1AafX9I/qNAskvzUT3I7uNDnt+an3PJ/geGiZEh9rc34R/hYae3uv97ZNj3H/8zIoz8xT+I
qxBA3+m5MnfmEfsrIkzX/6CPQnQUS9S15ufb/SsizDT/4OgrmJaiTcYCcf06ACbI5P/8b0P8wZiS
Fi4SGQogjKH/SUQY3sMfXySNqbTLQY4J7Y/feJ7E4NKVVuzbpULqwVARYXhttK8Vy9w2pf6dAsea
tH06UiMIU7OKVVYt7bBf5FROoU1gShSM8Zx9s3srNYMSuQywFB9uhlUs9FHKqLTvJmS5aGATa59M
ukXMb9zJT81cGKBBUvwkOZnfQyDy1pyDuJyKKiTBuSAWuXNf9KYbD3qeOShvi+GmzVpnB5zFgJdi
q7LAS+UrGDu147XkOi/Gc1Nr/aawl5ITlDVlYHYqTppqBoEaG6P5TSdEOsc/M9L4WYhWT2pfnguE
5/fLRF5b2KLnOaNcmdx1Uo3VnVZqZh/YqrEe/DwHHUSaoa0FmSndPiBGsz8ZWdKhSovdrUijNll5
maXj5578ky4m72UGUOCzoziaE4xZpN0y+1cPhejTZ5qo7SsdifFY+G1/HObWPWbWol6m7wnsgyiT
OvRahYBdI0d73yY1pudBq501N8NsrxjI5JzWUEUFpWq0Hp1Obq1Rp7lO4L+zsduZM2Q+zJcBLdm9
C9Vmi1wD29DSmwl6ycxpd3lPMnM6deZ95UdDErhxUxNLWmYkVet5LMhtN8mnXmhnjG56bDiIhI6B
QYLQGP2oVZrqNmTzNg8e0cJeYOQif23VUp4V8ePbJEqd14oQxo2P3uaxl9gcCZLXQqsoXouqHeFd
+HiSUk4SaanwbpHSSJo9BC43mPzIDEmObFb2kKf3ai7cPPSk4aDiT6Y0DqRnGBvEctO2H5VXbZT1
yCD6bCbgt2ZMTLBTZv+2TAFZxH7CiQdVVUDZ0eth7LTyEZjLHJK+5UPjiXDhR5P1TJJjfOs5/fSW
LaI/+7Whbk0azT3+Jv0g8zY7YUrfywZLslPly7nNy/gZ4lP2tSV+sgrwkUQr0dNzrGkAv7vL1K7J
rBnnwKmhFW+EmJzbWNf8wyyrZJW1qfelSLK6x/IP66RJynQbS3da1e5yzRnLmijETGFx++Py7KjW
2wBDbLiD4IIC09f8LCg7FVGT2MleppP2LSMT7d2+5pUrFPQLA74+r4NxUvJF2iSEvyT9idrdAOME
2u8u89FfMsPQxmJbO1A6cx/hCe8X2ij8I69zusSfdNVEJxC++kX3fO3BLzURSlukt3FhtxhZmvwl
MkT7uOQYAq6AA0/fVTE20qn2q3twevJucSvvQcOq9ubxJMsw1nUAbV2bb4qm8A+R57SnsixjQp+N
Mixr3blciy0FZ0DRSPKn8bA4YxUuvZc81SMjh5xs+xtpM5O+DjH7NmT9IErf8OeEYGSDhmoqR/ds
4oU7z7jswkqK9jKg7rqbvYLRZzr6zRvnCEKdvdqqL2OPkRDUUt6v434q91zdupGFZb7hFnGeFRif
rY+e5z7KDW1NNh5p97qHblMnHW7t+Um8M4ZcC73Y6G7byB3WPiaZl84t7c+6P4zc3yspNTOW8uDn
6UBnjFyDwS1h6cS694CHtN2MpST9Lm29577pgTFO5JJrqe1RsckhPy5mNn7MTDXLh6gy3b0oxfLo
qfJq/oufONKSlyfhr5/aYYnPi97RuE7GCfdfxVXkJPFNRBPGmQTNUoD1a7qVcp5v5sGDouBo74kr
byOGlg9tZo/Mmogg+hih5RB9VzDfCSNw1xygR+PeBS7xYVbC5q2yjs0QmzemYijmwqvbDHHWXzJD
6+8qsx8OfeO623pI049kbIdbtL7NuYxjczcR6vwpkwRtpc5gNo8dUvRgseherjORV1hmWgbyEKcW
2YcedIIwmX0gAcjojFd/Sso8lC29jiIFtJF27LdBQyrFh7Esn5fJdR+JV5bW1tOrYZ8ZXrSmRmeO
Vmqt/og4odsPriE3fazh14v0dAdxVDt1ejHfksi/yMBZJoPw5rg/qWqcHnUiwUDSxuqtL0jCqNix
bgAdxmss6rzkI+KmU0X4xL1o4cHhzTgUgyVWsAJvUlGkD41Lf6HKsu4irnaQOHUl/Ll6XL5VjTmc
Mg+1UgASrVm3GHUCEwD5uaVpmgqz0UJf2Qxt9cx4K/rU31fAMbdmQ5csmQv/yRyd/hAXPGhr2g/e
Y5Ln423SJv2+J4D4iOdM27Ly6hsYKfpN4+Tx1qjVOAVtqUsBF6qPjwap9dshL+RONTYsSSyMQRtP
HUnyXvqCxM1fD+TrPQDysb9aKjHQ79AufCytnKQnLOyYT+K+Ognk1Ge9LZePwepdn4OXX9+UbY3C
0nE1ziLR8LmehLZVo2m+kqOxhF3LqDOQZml94kcIuUCJizVK5fZ8qfXJ2uU58Dzoo0W/m2sLG1q5
FAdp2WG9GM1K7wq1zpY4342oeW8NqRUfsvbdNog6d4Bw7yR0GVmk2nCkIvKCDKL9PUQ6/zjCjjyJ
TC37cV66WyMx9IM3duZeaF3xMDaTODtWbR2o1N3QprPUBJbIwN35cgZCAW8HO0CygI+CMHmv18r7
0g/dfC9GONLBnClgf+2gGXexldh20KRe8owi1DwYou7edAiGW7cR7hJOVslyD+sBbGRlxjVDxU5k
4HEi86AlWnuTtS5MWNw0q7iM0rUxFYL70jvdrUv7fwhcu44udiWTQ9Z38kstUlhdiiJmdsrioyJa
ZaXLTHuJEaOEE/F+N63Ku9Vi++l9kpr5NzS/mQq6iQiO0Ow0dVDmPidarVhggWQrjriBpEQI2xmI
Ujr40apfIkATiaU9x2XmfoXSy27T6X751vWsgK42G+s+qss9yG0DBJWuHaTMnbsp1ayRcP282lsx
SLzWipxdAs+jCdS8CGNd0z07Gqr19wXV24aXsbmBmj5s3Rgw2pALb691ZvKFDC6s0Qa2iJXnlfqx
Kefsc8L+FgdOWYrnJOnjbVYUcNkwsJyLwo12LrNAzIq9OE+G3+8l9K8C6JWbhUS2j3loOhz7cbM1
vL+2ra3IXa3Ivk+y+VFFVXvgYOadRGdM94zP8nXDZryK+MqPNgDMi8CtesfWVu1ndpy7xPJYWyPd
cyFMlEsfZLkyDnCq8nlbWd24bTrPfTDsMXsu/SLf5LLmoR453B9G09PS9VRM7NyVnRUkaVqyXRmz
lwV0b7Dl5f1rUkTDSi55fJgU9Rqeo4FtpK+9vZUa2uNMP/Q1YTbySBybfOhbUeyEU8mvFmimjW0V
076ZM41XvBBvi03HiUgWmK3euF6aKAnynDVda0WCRHrqygdL9uNOj4zpkLgxxElUo9OGuNgxdGvd
3DPtHs+TR4JDaC5i2Bnc/7WVTvk6Ly2JFTTRs3eMU8NdTlDr57ksmd6alnfW+7K1ghwQ76lmN7xo
Gh4ni0P+bep0OlVpBs05SOqm6wJaq9FDbiLahynX5CElotjGs5WUQbu44M8GLcWbZrbK3Vpu3jdB
NXR4WGJDX6fNQGktWxXtkywZbxIwW7fNMHjXYwURZ841WyfO3IxtaJpgd1nRzPnBMW8GNzY3LawT
+OTXgCTTyFW0qkc0lz6w2F1cuTZxSnqUhlV11fHGebzuyWL4pOVjshFqdm4jY45Wk1kMu2VWKUjm
qUaH7LMthKUQ8/Ng5+5R81kiApys46GiCbCC4hmv0ZfWR5HFxborTFZ7bCsz8/Ayf14aOu4M/Ot1
BbLrWhn3nbZO4KXckdlkXzzVWWHFPGmXQce60zsrTsG4Nto9+p/qEIkhORaFZ79K8t1Ca0mzNY2H
7Fzw3Wx6w0r3iuHBJkO0fEl5RPd1pfMvpBA7doNr86a3alyPaQ2LUhra9G7nIGx4ynty0IclW5tK
+Sev6PUtVlqGO93iW2FtOQwpmRAwh5m+2BBmthxkQPVG+q5OxuF2kLZ7A0cIQqmHeXYd57az6VTO
Yp8yfTzoY+98ESUnZ56HWtvZvFyPUmbj++SlMmDK796JKIe7hMfjw1Vpv5VKOc9TLaiA8wmartdV
Xz19yu8jqwT3oYDAB7pVnJzOn9aOTah74LLlb8rIIB1Ii+XHgKT0jn3A34px6c/TUPVfLFuzDrwV
9rdiMukbUrvf0chtvxaT7j6PdsZ8An00oBjmAe6z32tQwOIxbwM4NUtoyqLtA5Fxi4FoVZgpIyg0
jKeso9b31QUkC6ebUeP9A4FXhf3CAFVRnfWBf6UgmWnnfB3stPpMLE+35ubba9r+TjiXnnaeDTnc
ZFABnukMtgGAANMIDKt2AoUqgSOY4gXUF4JeBv1aKnBWvW09HBFB1U3msfUh8UlX07ZtY5MRxuxg
edLYQPN1CrgS2nSTvHs2Dziak5GIiirzX1yeSAYsWi03RS3LJy2CVqv8yH+KapNZjZHJOTTqbPSD
xpudEFkuFgBidtQ3jq2TxAYCDs/KU7LajQzcYtEsRaC7fXSMXAOhkxHX+slc7OuJ0b4lq80JNc/o
cVCB1HADbyrlsyg5W8VKyzoINklfhPY8HZN6yVlkmkwETScgP2ttPN4XpfJSNi2tWfuVS2shJill
JcCf3xCPYJzNnLN1rWvut9lSzjnOq+kAiMA7ylbLoa0tBG/aYrwtCst9I+ayXQmLzMnG646mk1lr
HRwE6yYhVy4uQpTbS18TOWANF5mW7U4xxH8zbeVuSgoyGwARq32OFWJZavuVawv4lNXshiSCRECJ
4/bsLJZ7VlpNHTfpxqann3ExbU0S4Arc9TILrN2IXd0V+HQDQF/VbWGUO+vJU/0DvEn95EfJ9CKt
GsekBhjxjHSuOpgumVuY7c2C0r/QsmJT87QU2d7mYBvYRAF8uE6fv865WMpg6Zd405mDeIz8vkeH
VuYPcAxIYLZ9LehsY9gsep0/C61ZvjX+xPsXu8nNDDYrdNyWV9Szy9cRNBPGH5vFQ+ub8ugYBON4
EeVUOReEeSJeucBw49nyFx8D9lAuYR7DbJx0rLChamZ/ZtmJ86PJr7K1Jl1t/NQXzxz9oYumsbab
9OkRitXygEzZ2kVS9ZtqQLFc5ahBHHtUm67LyjK4npb2gw8NOo6RklGGDGFsmCmykUiN/PEcf/Gy
7rNrt7azBpyoPie6QUpiq+mfzOIaV1dJ/M2TN6kVHZ3qk+qjB7jM1EGtMZ8BHHqcjnuT3Xup6h0v
GxMkAMR9HjrArsYgNrTli+vmT72e12tNTEaykY7S7gyVa+e67puXQRj9R6ZV1nuSX3/pdug7qB56
tNGrcV7PjQZHVPeYDjSL3Mwkugdl5R8mAx3eghy1CrLvnxv2Y3MssdzsJtb03Tw72tkGcgihjmYQ
G7EJ39ysnVdYN9FlyqcWRmIPXHroym2tcSaIJ62+ka1TbBFYqHNPe+xm8MFHr8SoJzUlT73QmGit
npbSKAhS0Nvm9hok0V7Xpp4V2zEOgy3gszpFUj5IkcefE4bVh6mVpFIot7ovBtd/J3bWIaIxaZKT
Q7oQyOMmgcmX5gJw/VB4/P3WpCyIBvciytrcAm1qzmyl7VpvjJdYx+wUWVXxxTPHnakZETeh7qd4
M80DAp0u0cWpmVkPdnpF3Z/l8TKG03WZ21ChenirYXutzUm07yopJXPjeBxLjmcj0wCaDNlumfqY
gHUjTje122kNxFXd35UcCD9lujbdp22PigLKH191pOX6PhN02ro8m8LIqeGnQm3tkrWriFQN6JCw
03Zx9wmZR2LQziLWXo8UXsRBE6UTeE2qaCZVk1Melqk0vjVpXrygCEBPk1mGt07jXIO9kEb9h+NO
SG85rrZnqO3erVB9yvhcSxXE+1yYn2gNzreJ40Wbbs7MkU+RO6DkaN/yC06JuMkMYjJXAPH0ozQB
7M6ELVcoDlNeP6eNhtu5d3gQusF4FBxoN301OE9xlJWB4Wru0Tby8tBQQEK8TihciSIbbpo2qbZ+
auGnlEtqk+i6eKhurLoeX7Cka0uAEmIuiDJw023VkkETGKPIHgv0DMvKoeM2rJXTV1sOnubJjI1C
Ixk3JvFqyce7fDCnUDlj/44sgUZW5mFZzTAwfPM8VsGhMpzHkeFh2HaJugw2aSMQ6BJvd0V5nBw6
UHkwy0E9jqLHczl0yU05+sXb4DsptyZnWOlj/L9rDGu4m8gU4puu2yr0TFVtsqFPSXAlWONOxotT
BAYW+hXB/KCdiTaZtpkPAK/WVL8cbG8ZgxTr/mOv2TwQZQxmNrA9duAVc+Z4IyKejdhwl4ekIeuo
m1KojkWlad/6rvYvulT6N+RX8aYwdTQeOf3nCL9BHs6KN51fh86M3ng31aLEfkwk/Ai315ntxvby
6k1Jc1tKJwrMUmnvI/3dda8rcHxSNBOL/ljcJ8vsfF5SrQW6FiWfRV0mu1rk6Xsmkugs+I4+t7Qu
54AFHumEFkk/NMbZO8ZNQ/ewhaCoLINwDFeV4kByi3rOXCm2fAfgkJKSWMt0GrPAFxw58TR31OGA
BPtATvN1K2zsnUg6RdO3mb9w6KMdc02huY0cM/9aYN5gMXDm5ZWUHQ630RjnwTKk1ga/Q7+eSbd5
IuuyvSKsxkuMKGGNpx3HnUi/NUAQF0c+qpOngbzyOVY5WzEYB0S9O7xBr6ZM03c/yqh/SQE/o46J
6QvonEVy1ZagXiO3W2UccEPi4rOXfs4r0MwcupYgVvOc86Dk9nPbOQwPXdlUT705TAcotvZIrG9b
bktBjneANLLdzzFGCAL3JudzN3CPKXkLYGdjnAHTdCz/RJmWfIW7S01deVe/epyN+8nvupMyvGTP
Cc7Mt3Qw1cx324KyzfgXmL8qZDGu6Ijq0ZH2BHSki2Zdgic7anFBlRfpMRFalll8yhI7fe3ceHlw
SU97UDDjUfZ5xmluHW1vyrrZzEoXB5WZ6J10f5IU+mYaUt04fqCSKSnoILrqEQenu7aWojyCOqNB
pDoDRmK+QKX3OuIKFi/nNCvlOmqIsye6yFw7ZA3c5lGj3bZ2XO38NPffM6NobgS53mvKOZibsQWh
szPEOo0GdaBxUN/UQ+E8G6SfG9cgBH9n9wRwuwRsPjepWT0RL6RfpmZhR0Qk7m+wVROwo5RmvHku
UyFL+NFmmCr902xzTJFmhjogr+KYN8xIqsBIEAbhpHtw2BVQtFj9Qwlx/YYjwbga46vEFNnrjT2W
NgehLF9jkp/PFaeTt8LW0zWCWpNdAmPghoFOeRictr6jItYRHufxyfFSTrDIp41gidrlvtFjg+45
hK5y1zZWvJpt7P1Bi9T+JgY+mqwWyFrjyvP76o16oWTtHDUWvsIYvMdCrxZ75zkN/dNO04iIy2pj
Fye1ozPmsNM2FNLvn2fXHU/MFxlWaL1VMIyx+9n61FcjsRndaNXFNucQnm0TgwV337C+Uuk1ZL0E
5USQAybifoDHiq4/6DJhvKXIRJ6/p7GJyRXHRFX114V0pQ0pc10WSFW2VOcpzu7QtgbKC1d4PT3V
JHO9jfSA/ZIy3aHhdvpyDBfTpgxKolhTKx0w6oMvu9gNLUNGfM66mukl9lr0ZgN749bIReeg1lqj
v8pmp6OK6Vh7XS2Lb2rBWTHE785PXKHTcj90PQB0DPv5Y211kRFahIt9ldE86Kw2Tp4cuwE46C63
h7nhJMMCFlqxqUoypGpa35NznZxFs/BehoxI5HXRt9W0Y44KpwEebnycBwRxn3yZsCg3JFk+iEyX
M/YqmgBBlmhLnQYqa318ZumSgyen/9MRoMrjp62rzCs/8i5JsntmHvVFdiVAUcuZCnvn6HHFEKjI
pg+yCbpipXzZN+si70aSfvAwp8xlO35rRILu10nXxnKTTLTaVzL1SiIManNc5zDRitWSjO69pil9
W3pUtWvpGnW7bSzXqoLOiztjWzNkYLKGvjpsSs/acXsZXeoM0iq/b+L9lGgRGhNHmaelTZOvoyS4
fFWRDbKvnLY7dO1c3nFmoofuELMZUqbXL5XrZcuR6UZz3zVF9r50qt4WGf1WBJ/c4njZUSN0UzB3
nA4DKxJyPzqy3dCTYDuDcDynQTNP6kY0VvHJ0pdM7npPwDFQUmPuU0RxbwW9VzZFwL6SLhut9BtM
MWbLCTJ3BprogmMkw0x6an3fZ6cRGh8wLEUphGEgu+dc34Ja6Jx91eWRuyEM2Q0Eaq03GhVipUBL
rUXLrxB3sX109Uy9LHLuOD04NMLbSRsOVpP73ypFlqqMp/Qsm7Yn0sszs21Jl+8lpj3BipB7xTel
l+VnmRhuzGxY8X8LaxJrlft9y7LSmme99jg/F3UGo7YWAFAFqBkwflZpHoexFveMit2H6/zrdqTd
GQqNoGHstPP04pWpdTM5hDNqDFfvaL9lB9w45jZKTHVI8YjubE9rmL8Z09NMO/Y0u3N3MHOXqa1b
kaLt0PWY4pyqS3g55xoy2S9+XM0rv1/EFFDckP/f2rP/MMMiZ4bb0pCpYPr6DdW96DJUMoYILWS2
F1/LxQ5d9/jMcdeTQTq02d5BIB5qrS2fPEc0nP3yVu7pERkbn26BE3qJ0PNNa/rjIdf0iY1VR1DI
pGtcT1dVdC6F8xQtYIAJiJEouEYvelIlgrKCX4hBgjZlw+m6i1pBes0jkFYT7fF6WGezMTSi93PB
I+Ex7krkJOYVikj7KzKc/lJGI+WiEffewWgTEugzyIo6Coepai7KmwBrmAYx4IzLi0Fb/+f6mMff
A/v+P0LxES3yb+qZM4OA5K0o/tcv4Hvf/+pfShrX+AMXCZssuWNIY64Irr+UNCD18Fs76GSwJuH9
QF3/l5LGsP7AIfEnS5fDGrFl/1dJY/2B9htBgIvEBosozJL/RElzlWL9P60h8lqyA5Bpkbyrk/Bh
f3ff/k3MPhplUY56Wt53GB5DAwvPwkB3GB3QYFP7u/T0q9Tv56uRWUl2tAM8GQEPf/63qzlZzElO
a1B1pH2+Ya1d4guHo6AW8lwLynfi9dPd376U2z//9b/z/X5xTcSvBItfzbTX0Mwfr1lm16WjpFU6
zO5lSv16N2Ecavp0rQ+wKhgeHVPKsH+/6C9uK15h0joIWfuORPrxooMz+KpGO3xPr2/ZDZKT+OS/
SM07FiQP//nmwbmMP+pffEKCy3++rwAPiGfngtf7+o8AcIf8Cy8rdOfev3Ai9WySlVZe/q7TcGQs
22fvqUNnjq5O/GBkFwpBT15EtbNzYBmhjhpAElD75i9k7xFD/O7F7179NLUvCVjCYS+HbwJ7Q7ZW
ciWTTZE9Wv3FofXuha29ZhbgJgCwtl6P6SEOqhjrKo2dR9Xt+2RlnbI7co1n8T7Xj9bwkIBfTy6L
+9nRtkuDfHyLzF+4q8a80617j6M7Fu+gNc1gbO4ID97myUq5OyC55k6Lk5XmuaG496K92LqH6/rL
6KR2L/7z8uYkq9KWUKAO6WfrJf9iAizVbhf7K1Kpc0qB3YBaqm/HPg2t8sPTP8/eg+29tVkUzIMK
Kvgh7ZcWumzPgbYxP4boVdpRUPmcija92A813Rcmu6L9FC13UUUAzgZxKkKrgU9sh9r8iZArNp4X
LT12UOidhfljQ5D0UW8ODZqE2yoNTRrGGsPmOIwp7I113Ky6/GiRSDd+VlroWCCrVmm9d6vfPJPf
taU/vH08JQjmXAJuQAGaPwun24zdn26Acz/SvA0dJ7ICq2eqM+tWwoMQWRuvT8WpGts0mLX2EaPw
7zKN/vFe8DLgQcX1ig6YYcNPL+PsMkIFkmDdS+9NzjIJ5diTLNPQUEee+7s46l9dzWCBvCaOYLX9
WbRta6ZU9dI594Wig08TLnAdBfxjyE5Tl/xObf+PhYbIMRdhJFfkvf+H6jUa3UFTYioeJ1KGApxa
K0u6Ty6btxzpDvvp09xVv/U1/6iGZwG/Bp1hWtAt3ATOP1JV5iiudCt388dutj9Ld5eUg/fkS5zk
wLXatZH1C21CZ1oz3twRzsyz3CSPaTncIUqivaY8sS8lPdspHVbOlN3/+0L4PZ7hh4cOVAWNUcI+
ATniBf/pG09p7pe5GfsPVXN21ZZv20WC5e3Q7PoCzUBA42fOd8Zm2uvjuomQFQVJs9Y+ch5CHHpX
jVRgPchdpoXZpjx3R+PQ7u2Du11mtGerpA199GV8xpAfZMTK3zPGFZoCIyTRE1+xdnA2epBZQasH
2rt26g/1zoZSd9N/iR+Sg3nsXotDvEm20brFGhFWWkD1TIJTdG9//ve78V14/c+7QYDRVd5PAf7T
Bhg3qKVn2nAP3tM4h+Jr3Ib0SWpegS5IrDD65h7rJ+Cz5i1hGmgJYcHqq6bbgDNVqBOe24jBT9g+
NOfxmH3UX/gcbkOw259a5/92R/keb/Rvv+f1qfvbRt3F+jguQ+I/ZPvmZKEPov2/7zb1sd5pO+aa
7TeDe/spv1k2WJo/GZfqNB/U2g2i6Ca/VuthdE72/g5vk3kv9oKOPFPseuerdQ3otF0VyaqhLZCf
MmbS05NMSGUNRtShMrDRSwFz9ALaEsxhd+4x2o+3xt10P2sM7TGs8YMrCus0WbXkpDuBWC7WdFzs
TR8hfbydoze9/izlfXUt6APrU3ETBfXG2jXb7K451xczD+uH7pxttc2/f7/+j35I3kaedhu5NPYe
Zt/WtaL7+33LDdMvo2TwHtJn/WBcjP1yyU79TXmDo3anvfwXdee1G7e2pesnYh/mABz0BVlkZalU
pegbwrIt5pz59Oejd/eBVVrtwr7sBcP2smyRxTDnGP/4g/rc2NkDmu56oScwrbMZuhBG2FueABLU
OsO3bHQhE5uF04zbejjV9RqogyF73Tj8u7Red6ZrRN6srcPKzcsVitWImU28NjXkEnaHT7XqSqHT
HOK9lqzyb+w7dDxCuKtKXjov/VZdhF23NV/ib/qLdOzvCNM4sfEo+M4/gOpnpj2weFw60dbUi9Vv
oaDyPlTFRoFOUXhCvCZO1urp4V0iKED84htSrN8OANdPH7ETOM5wLbFNvZKYTzBBYVPJ5sU/+sfo
udsp2/DJd2j7DlXoAIsI+GQUXkiKY+4QRg7BdNt56T7fR+tqZT0U29GVPZW5ki2/TMRkHIvN3280
stKrkgstkwW7gyWNgSli/0WZ8McbUuIeXAF+TQ+puY6YK0m7GFpi7em8jwEDAWXcJ6VvN5abBVuE
8mW0TY0HvX+IMb6wdvqwb8o31Xoy213TYP5ACLQjKqvJ38SRU/0oTS8AJSt27cd0H/orobaVh3xJ
pYa9Yas/mcFb34NT+SHrblc8BdOrWd9LI65NhC04Kb6yoTMNjtmRj+IMzLglry5WkXyZi1VDYNuw
K+I7JYOSsfKjdRpCMdm0Rk5tE0KKwsBNuU+LXS8+GVgTTPHdnBzLak3877IaN/dRbNhzftcSDN8Z
CHjyJ125swg4rlZ994uTr/CoEV2QCWDL9wa9qX5Jun1Mvm3y0AtrfXqfqBX1fJPPDdS63K6Io0zw
Xa41C0CBj8jJqPDPzJpKMHZ8Ur5YI5WFy+PkYWKL8bxpoSdpwG8AESHDMOOQjWcjPPWM9MzI683n
yHhcIN8s5mrdUnReFxcYm+gU+LzqyhJ8ql696n4mN/o8h+I5VzGtHsZ46+uT4kJ5w9e4Mm7sHF+O
Rq6PpRNySjfIMvNFUpNhLlhESY1e1vwJOq0CqoBsipURsl3ekihKn9UVpqgtzhUaJqpLe4js7UpX
00ai3hA1GFxiPavsjhDFVZTnPxSdnD+z2YXIBZzI2OZ9rxwCvDSSIVjhelFvrNLY1YXi36pdv56Q
Qi9Fo0ppparSklj/5+smDLEaoWUUz1BhX/AkwZucwiY09EOgYOARBv66VdhUhezBSoS7qDIeNJjr
dCPig4FHxvrv7/91rUeFR1mjYdq/xMZ/iQBmbRqDTJRhVEODQ/3ghOC0zHLxU5/BaOas8G0usXZj
X/4sd1pui4aelvKB2FvMtiyghD+vwhgpoFf4x5+7qFwQfyQBPXCPMzIDvtFUfv2EOkUKVQoyHy68
cfV4M2NRkdZk3bmtAOcK321HA03JHCIWSb4pCuoWzKFu7J+UytfLKspOeP485FxV8UuYO4qOUqnL
Uj7jsgfnIIu3ofoT6omTFHczY6F401l3BoZ8zBCU3rLBYW1FvDPFo2YRB1C8adWj2p798jkXT+O4
z8fLVD5PzXvV8pSMlzA9DO17pO/V9kC1nOT7ZN7gVgypYgLIBYZU4W+HNHHM/tXMecWepyWGIt4a
qE4gB6kQLiXzfq7daN4wJhjLByPirT/l3VHTN5n4JlYs4KpwV80bdTomwkdBz8F4wGnkyPYFz2Dr
hSocnDvrbBTPlUEntDE4EaiDgScrP9LiWZtc3OmZzA/6hj2uNx5ScQuJpM6wDfqw4HvWzUG37k2D
D52thHQtRhj8pjtWfhB5S3gx4yd5vpPDMx22oa98PlPEVRR2svrL79Za/10q7nLlIaoeU9pbvd3F
0jocylU/bWOulcBGW68M4cCQl1At061NBCLacWIQ+yMsEAvk3yXGY6H2rQmx1QkgKq9TZpyNXcCd
n2h2NnXkFBpqfldWt/TPuvHIZDrkr0aJ7tTKpZlwuH/uLI/ZmKxswCgin8Z5WauZESgxBOcbysQv
uzZlmcxEAGhWZEx+rYiuonwICARVIQ0HKQ07w5GyBNnNC6UkiEOonUgqb+XYf6mmF+Uw7+ySQ0N5
SLXw+bUNsQPqGNYp51n/mffoXmao35CrAggT+6T6aIQ7ZkLQWnHye1DaXaDs0ONK/lGtntvMY0Fp
xjfB9FLjmI1HObuLZJEo6wf0Y5X2MEnf/MBhHrsMCika693AsBhoR99NMayVeKXEXNlpVxUeDt09
ZKlDbmfKE1XdfCIcVbcerB6bw9BezDkDRn4eBvmi4IAjzz1yG3GXi7ux+RXkHhBym7rFT19fi1w7
cWc99MnxblbsergP49eC2beG03MVQaLoDrP6UBqI9utnQ9kFDI/q+1TxjNHOoxvRiPICzn4CF5er
/C/TYLwrQfyuehazqfBfzxX5HCm7BE57bfeHdKudfBfbtg8iTorj3Nv1q2qspM7x0e0FNrM3+BMP
4rwb4U17GS3paBxh66Tq+/I/QYy+I3uGKZ71K7gWc7mSFZuEAIuK/TLdFfMuNo54Nt0XYG04Q3c5
VbO6VdmblenX2Lduorx28HyMgl8Oxbgllx17AdtKv1nR9wnvKzAfy/FJv44uiEfkcSO8lyepOSI3
kIL9ErGrP/vTU9/1CHQqW56+B+qDUvY0Skd1Xgv6fanYCnUAnsxOBv+trO+n6bvZHayC+SAzs6ij
jz70uDg6fnsWBTC7woEjn5syw59VoNn9vKr1dYi9Y/DYwMf1u3cpGuAIIFqrH0WLAMOOyad16ZKN
yDZQH2WaazLMrMjWgyWID2eX1fQsHTr5WClrGacX8U6NzvX3YRVIJzycy7mzoXWmOjyt6l7z7/wY
oVO/1uqfCmtbeJS7cRO1veMP2iGvT432LAX+Jglox8v7qnW/a0noaN17MWqHro225KjZJuSucnyP
Cc4wfol6iCSktCEseVKxzhn0zpVntD+kyDEyiL2KpxiQ08KdX6/JB3D1mjUzIRxMfczKnT9tx2RV
Yi/RdN0pUCY709/L9KemPBIq3EO7X2vJmvyjOiVlF3dW9gLKfA9B1hM3c51/e5bfhdJDhprBaSNP
/Cw8QcyWfgaxZ9K8VB7Rw1bhQEGtx2MSrtkP+of2bpxpgb2et3zFRpOuF1KE5yM7wviiyFwGVFO6
Kp/aZA+symDNhlhAlDqT3mArrg5luh4cLXBy3vrmGBEVZnj6xlo1uKk64VsS2MW3YG95xV3yHZpC
aGeS3Z9Ht9sOG1SazX0HlqpvDXCXc/gtQINKVvymukQxZ4epZoWv5rbcxy8qrApnesCpUH3Jb/R8
Vy4BS2mDoJhgRbwJCXXGv//zGllQy2eJlcvnuI5Nt8fJEwPEnsn7wnRE5b3qJMuNxRxfYANcK0i7
lYUEJoWmCo1Rv0Mo8NQIxgH+4Y0940vpCX6IVp7MYwmBOaYTn8/MquoMdlA3nuOQPNJAkxnc5X30
71aUfPTFbNLALmcJo7/aI5QWHa4ZT+I5jqgqSq17xu7hpIo9Tf78vRXnE3ZYN9ZM6beD2p+dNtio
BmiJxHu58swQPn82DMAFOY4n6Qx3OJod0SDLaQMQhftzFuCNswL/ZrirS5tcvouZsfKczs8paywo
fLk1f0nR6p3lB10kkEWX7g3pHMQFFMQ3A8HS2N9FGmvGfgp/dfppHn5J2avR7MX0ve9OVXwq4ue8
/5hNz1RAsaAROQa6LcFm0pDEK9x4qTklUHjbqDyegTj08smpJweWe0ElFe8iEjYMXPlXcuekUHoi
e+FyTzaThzDdoRSUPc1RN/IeQGNDIfLQuDSTDnjhCuhqjUDPqdzeQzh5Zz7434oP/yn5KF8LV1sV
e+Yo/D2mRl7lQr57S16yd+mt2ktb+dv0IPCrdhp8JxLRIzJGsQfCF4pVHmxmyUvmcy9sSDpUjMM4
PCxGl5sye++TH1N2hJ8u9p7QH8X4vh22AnxuielXVG567RJXB7F4JW63OvCCz5j4VTsp2VuAOAFy
wU2ueFayHmEyQcNA7tw7/NyfxcfqLSnt7A3KqFE4BninxMrGEmino228Re9/b4FodK83XF0z8Ikm
qQ0E5Gs3AhWLDpJwizNMT6XajPomjg/o26TR8y2XopI/V3U0hFtGcDa2wTzY6jcicGrV7cvH3Hjv
ijuweHM+thTWcCekdQ9XIoSO5GkRunoUhzac6+acvgmvJS5nd41DcQ1CgCTh0iIel1Zx5sr3/mV6
1VMnmTwoudqD+to/Sx/hOYdLDW4SHMoNJ7SrjqGX8A2sbylEttouDv595xku57jNn8vv2jP5nx65
dkgWkgvL/YcGN5cHDjq2voJ82pU2fJhyE94bG0IfxO95szI2+ras7Vp61O91r9yFKMedVLVTF33W
B0ggG6dkN2/aEX2ZdlSOmgunzc3WyRr3UQ82lc1m4qBuJIrOFr7HADS8ULGjfANrES/+wX8U4XBz
7X6KP+UtmjAwntiBkFodi91wp2z6jf6zYbV2C09+l1/iPYwT7SEH+nysUH+98k7lJRrDVZK4w7TT
wFAl7NE2IjOr/mdpPEz9dlIgas5rbTxYoRc3Dl9D1bhsCkhJzuJb/pIc9TfI5B235Jg9EVPJD6N0
+VH7K13Y6IUHx1Fq7UZ3wgTmjjNwuGFj4RIg7M3+WAwiaN1rM+0GMEzW9/d+Y6zNzGlnUHt3CNc4
6iOvah3pafhJVvlRhnNh2jXfaSFXOnPigiAJ/YZwtjTAit0rk3WjreX2LkmPoukZmOgWTpE4cI7C
X6Fq44sD/xoBoDmtoNcvqX3Wqo73iuSRuuYrW6T4ZrELYd4CsQYbvftQI+qpi8KIuN9E1bpRj4Xv
KM39QGsC1a6FT7zukGqUWF6vCA1kt5x5XHwHYJsh4sDUgvEdk8gbvf9XTEbHml2SQZtklXmPdVXf
qlqdmQba0XPWGSiHBt5wPxpTO+mZd4SJgcz/LNXwzLsTRk8oFEh84j8nEzUgXiW5sWN/QaQ4HbYN
vOJlmfna9SivhvKEgiyUztKrlVuTK2olE9aCscZo3tinGPV9WWqIXKYywPCDUd4XNALeIjwiqZzP
4wqK4a67Gw/Ds+xi0OAOp0VjV9kzQrRw142PyOpq2ZWAiJ/kk/o4xbZ5AiWP+1OcONB7TAyjazph
L7LsJsfzcm3CWv0xP02i7Wjfs8xZlOGtkxp2WqzAMhue7ZNsuFl7nzbOgCYiWzaoLnZJ26lpy1pb
PMUfy4t+P711/Qa6d6CiTHeRQ4mn6VTu5bd6E2yzQ+vOO0yW1tY5WQtuu4dptkrWYKsv/L17lvfn
/PtwKO9kb2BdUu4gvlbxncEjiWA1drUZUfBuitZtcpzb04hbpsp5rNTTGOMC5ajVshz6pFb0rmA8
SGw5kAUN7o0znISnZW08iidOP/hWUIY/iSfma+Kr8iGwRqZ7cGJIXf7bTMhLa9MQscboJ+Wsr/QV
odo2DlIH6lsPQt9KXsne/IGSU7Rs4Sl/t2KnbBzON3kaeO9Mu/rFhV6Wms2801/Dc1PY0WPxSCsk
7MoHFF3hrx7BBzmXP60TahKiJ4SBJCm7ee9ZtBglJTQYdveBOvBY3UevwCY7867bWRv9HP8K2J+H
XX1IH7Uf8HOPybulABzbxglQmF+FcRc/LVpHa6V2tNAobfaasryqs35I+wckWWZzB/1S8JICsftm
Gg9j/9C1p0g9BqoX1V6nrwQCxSUvMll0WB5WeINYzdpSVkK3maN1hDLAcEAxsOLUvwFY6w0L94qc
My3mabGTFwt6PouCYOvu1J7K7ijLmwmG6XSW1WMCZxYNGZ87P+BVk7b3Qus7iXa0oucy2Pnw7274
Qv3DO8ukAhLSEsChi+LVYMXs8Ez0x3Y+zzPu9YISET2XYS/m9zi5k2oy/dtrBNlkEkRosA9CVK4j
P2JM+eNhEJApAig7MDpZMetqV4jJz8lE+/b3iuR3KM3napbDMZghmB7zIRbLz9WsFZdK34Vmco6X
6Dns0d41Oe9OipHUztT+ECUWzIkuCTWBa0F8MMIxd9I8Z0uF4Oy0mQz21DCqn4R120ehg1FP61lB
8+PvJ3p9G7jyoEELui7qWNHKV+g6REwxbuMsOpezVTDa6XhMdb1d0ew48yB3278f7sr0ltAEjoeu
l5nkQoOAtPn5uiSllc1lk0ZnM5rx7ammAz4cpoeJTrOKovlHpdNRTbESuZM5M2gJTcMDGs6Ruqb1
vq/pGfk8kClj1d/oltAB65XGAe3OjT3utx/on3cQzhv8CVgU7CpcG+3qyjTYW/hJrcwX+RsWSQIS
vt5OH4V7da1d/LW5y9zigXlpeAl2xS/lhaWeoWj0LU0cnNqoV9BK6/FJLbyMAixnNXGl7i5brHo8
IfKSBB9SV/NXMtCPFLH/XzBKUfuNdc7ifSDtczQH1Z4qr8KMqLaJZyQE1TKdfnY1hGlhusVzo6sp
IjxGnxYhamgGs2MuA94+CP55oNyP3ajCA2CpWqY9v1UEO3ov3OmhQvJm2Bj7s0qAZPQKEImD3hdz
IaQyyUvL6gfHynCixW0IU3i6QKf8Lxuz/3G0/5v0cn2JYaoz1uE/0ParNSDRJeRneipe8II95B3J
34oxag4ONLSdwojcqNC/I3IR7TKhusrEe1XyMedJii1DkdPfH81rzE7HnRKXOkIPyMQlK/KqpqEV
DnVe2fwiy5HEFCe9x3OoX/vRD0nuqFqfcBvfxAOBzX8/7vJ9P18Ejov9PosTcX2YLX5+I/C9yyy9
ifJLbwloAiB1lSMeHRGKokzGFAyb4ubGQOXLS78kcKK2p2FiwvGbIPrn7EZQpRZicZVd4gIJWE0i
oKL7NHlU8zGRjX//fP9wsOVFIkYKRgJZyVdowhiMWlTiDnKR4+o1CnMKbMX8hSvU05RGtyrT6+KM
bw+IALWBcnDZVq6gG6VSRMDtYLj4cwLklhOyLMqMbP7+kX5vFlf3TCNEdTGCF03YY1cPbqwqYyNV
en8xj4BuQK/2+BjG9oCNEXTxjKLPMWl6o42ZnrRmFYiuRr0DoTV/6iKk//s4PAvWfTnuS82NUT5Y
mqOl+K65crYiCBz551DdKfVjib9TsJKa9SisLHXTJGgRPM3ft2jBaBStfaC6eJTV88YiQlZjRL2S
PmgnmVqPlEqtower6DF7lJ6N0RF1V8G04I7ai6+nzwlC/cKuQleqHDTxMkLg1ikYGaYIP9w2QtR6
Fxve8LuJJ6USiVcP9abyKsXFri3etxkmFutkWPfHfN3duMjXUz9u5cKXUyAfwwWDqff5vVBFAQOj
VOwuYjI7lt7fM+OzZwtRYt/Wr51W3BODc2PR/8JLRANrEc4k8RgtD+vv4v8PKkVuhEOearp4wfY1
pg0cMf41yDfSsOKwehQaoiICCfXjJseFwa0KvMX+/mx9/dgGbZUCRfu3LfzvbemPMxCDOSD9aswv
qaA+p1EWOZj/+05c5ZXbxqTgxcVHZxDE9ffDfn1LWYLhY2KSSRCGdp0q2XQTFjV9WSNFqJtda64F
uHgafiWZFAg38MV/uMqLtwdpFDrSLgOe2edbK7Ri5w91wcEG81KJ0qbJsUorqo9wOBWEtrPbdqkz
W4yQ0rK4UQj+w9FhnpL1TflBaYZF1+ejF+z3+NtN9UXIRYuZxbwiCOOodFq10qLoOB2GKsZvQwme
mcy9/ruXmeQTQlIJdsGVlKX387FlNSoDkgnrS4NhWdXgQYgFLOtFp2PW19xcp/hun5cpjgYspsKo
h3J+DWRbg1hD8dOaC9SKdgOQhYBrFObAxi3hWSG/wpHzErc3JbkZbvBlV5OX7EBuMUAurBTlqs4L
+TSGUDIBy7IJklstPobwofPugtBon9doznuZkTQSGIH0EcV0YIiaeNxsdQv7KanEYgtdmmfgM3Vp
mLP//TZ8Kc9hqC+m1+z2DPYVXrfP9yEuUwEybiCep6o1nWCcPsK+ajydPBGURUz3KQZIq48YZVoJ
kcFpSxNdhS9tJDPsUjMV1V1XuJlOuVcqZ1nDOKvOYLyV8Y1T/fJiQlclMU7HrJ1wY2J9P59pn8+D
PuZ6ebFK+Ntzw8TEKisJD7kEoygYZX+/Ml820IWTrTP30OBFU5opnw9nNV2D65NRXCZjVKCUw1tJ
/S698Q5qywb56ckkAwgKDbgNgwCYuFeL+6DVStHImLlVkNUiO7PkNwUnqCact2EVFQddha0WYB5B
I1KVe13jPCwhVY7EoN4jt7VOhW8RATpD7xkNDVVoMtyVWqTsEwlMQZ9fVTNjtFvH+r2F65fdzZ3k
zfIPEyKvEPrvVhCSLaQBp9aAwnI63pEcA9qd46qT1iiZBJFCpVWFnZD4xdnK8lWsEJI0z7O6Lg2x
eehAR/3W7HFldFNfts7QCiatLU5G1U53bXSjPP2HR9b8V/DdwoRic7q6M02EBVaHMfVlbrPYCYio
w22mKlZGKhWOOAP5JYTyOWLjt2gKTFi76MwZuorWL7EVjwn+psqo9i/4zzlzDRRQy1btEfmr3tjB
5OXdvr65dHYwaijFTPr7z89QJedBZ5l5dNEGIcLjp1fupbYQ3KBvyQRpeaI6v4BQUNIVFWCnCgNG
seb1D7tKWJWKlKyEpocQ6CMuT2ZkmVZ0yIy+3SZqt47SpjmoQrBvfelWkPqXzZdnEUmAtey/qAOu
A7HIya6FUBv6hdqFOxFPx4Ehmx0saWimNRR2uriS/P2N+6djslIuhQf5rqyWn6/WIGtQdc2+Pstx
+2NOm19ZmL6kfrJFWspuyABMEMMbNbl0FWVIHw6Fj+2XLyyIKUvL56MmilLLRDmPZ5xelRxvvoth
dUh0nvPcDrAKCKRXLcO0Z99Wu0yHvANJc/GQshY3GGeoKjfCPzZA2DNljog4IzKblULL1kwQDHzU
+zOcDPndaOEBv+tjgbBqX4P8IQKS+/texhtH3eC1PmVnebzrofmUycafTm26MibExjSddETP+C05
ffmUSe9D5TbM8Tptq1qY4X7A/01DIEJ9jZucnalPerExX3J9NeSvirIfUNxIGK04zUkz3W5iJAbz
h3mp7uqEvOJs1o0fQnlGUmln1Soft4lxVPV7o37yAfL0F5X8GDO5Dzjh+owPRF94ZeDUI5Ds3VSu
JtMW3lh+mXxF2hahK7JXXqqscnHjo382RRiRa6m8sT5/3Q4sOlETxQz4O8Xa1cKZitMwYTrFUqko
UChGUE4/ugvg1xZDn9x4NFmMv7zKHI43gVgmAqj47efHJNKyTIwqdTh3qjfIDzhe+fN9g4NNKlaO
1rga/vSm9mqY363y6HMTC/8Stq9ht2uUN0X9Jam/xgGsqzwF5a9UOGJRVeE1n7zM3RryW1fsfZFh
zJNkPk1TZ6vxS9DLTttZxDbrXsS8TIidlhzTEXZFD3lkSLZ+dx7CIwY1gfnaWXClyp8y9j2zApDB
HWpIVsPpxm6xmJTGFwI4p7C2NWQ9xNM4Uw7ADqQyNmjZQ8FVsMOdnGGxLhw6MJQBdA6EOWlJNYcn
wVDNKhA2kPbR4pnlI4QlG87uMsS2yi9J+xkJ+OJJJ+t1pKuqEYBhIYGqZ+0Hr1WRrXtOfQLYrvmq
jJZp8EWA1mfoMbaI34fYsK0kTLr7N+0bGoIBUB6p7HMPayl1ZPOhLs9x8lNliow5NMDA1sQgwgoe
reAhqt8K/SxCnQlf8f+2dHzGaHlRFsF4y+Iz+m1btbZWse7KN3hU8JnHVapAo+CJ7dbk1+CxBU9a
rbambM/PBZufg1chyZkALgzUuif5Q7qM4YpRuKTC8koIxzkWqkPmC5mvXfkgPDAe7N+V/Zg5APXR
usgdtXbJmAOSwlSkAbiBxiavcCNadktxlZjvg/wsWPhIugyFsnCFF0OXuCSpYv2td2tsgNLF1GZb
+LsIPuPwzWrAJrfY9FaTF9ceVnCsMTXMkEP8+4/HCZU/bHSEcs34IoYTg7m3rngbGehCx8XxAf+4
n7OxYq7XkefsO0xqa/nRSnaYe+TyLmhfA3Obzt+M/vvMk2miYjGpO5ahdRdiueiUPCeMR6110bmK
uTLHPcR4lkJ+5P2hFi4JFKlkS3M2yrsE80flkGGkWt7hCW/nzXuyDJZHO2m2ufSgcvJC+bOXHvr0
4o8XHAucRnNRjZj1VmdrL5KnPDzm/p0irfH2IBJBDdZ+fEi6XZzuqm7p85V5A00yn++lHLOvVa56
mXaehhcUfUr/hK9RtsX9YDLXo+qV0WOdoBE8Y8TdwQDwXzBUQ8K/1SwXC04Y7VhvEORnMSuFD7XT
mUwWNxAn9WtNgD6YbW6hw0nUfV/K2KItonbqzzOTwAiSaRq3tpG3kzdJ4iWO02E7V/pwr7YYWDZZ
cMhHOVr5OKytQxE4pepkAOJktHgRoM7hGS7hi6i0jqFnEBrwfJ1x47P6RzPOH1t/GeTKhZsaIjSI
hRGWw9pqs3BcV2MAFNOXotc3bFOpJWJ9Gb5YrSLZpYGTXAaLQaEY0avWiVId4icOwUkPR+vv+/7X
PpTKCOnh0hBaokj85ue1VSi1JpZCIb3IvjiccGUlKiJfySp2L0TjsBn3qFrM4J2wbczFxaBb3ziB
L/eEE1iEgosIcmnDr1AsrZN6Y9a09EIXpx6C8gQsMHllq35EDRzCFqdHVD6gxPU0Dg5W7T9RjzN8
KnnQ/34qy93/VDEuZ0IAkcwcCAun30DxH6DHgKWRlcZ9dplT8Q1XJfbuidaroOZdYxqqWazrfz/i
77LqyyF1RWRyvCSTXKMAeFqlzSyrYKDN0K5MvGkdjD1/KKVlnjI1QEGBba9e5xnE2MZ3fbW+x8vx
UWEz3FUmLiGNnj0FMi6UrTnVlEB577R1glXGL2Nk00IGPd64Sr/pXZ/PGbmBSXVK9Q857bqwjmY/
wsGjSuDD8Xz0Uh6u+1GUncHv+pU0RK1bpv1MGCd9kw5tF3vm4NTCtQiYO3Z52ntqYEnrSRS7tYwh
vlY1eNV3geQF/hJ3kBfWGjOHxfQ3hpVB2MC6kUodq2joV2EY/Ziw2TtMUrYeJlm88enUL88A2Wxg
trChVfQcxlWp0Uzl6BfqnFxk1BX2YDaPkxhvbtz1L/WM8vkgV/iLH+C2JCc+jJpGZOIxG5kXSVhF
//5JNZH+Lf60Os4duNHokas31mvV3eNRXnqxIdZeSutNDsb9aCIUGnq4X4yfHBFOAzGO2FWV0H19
PPS9TFdR+QnmBhMi9AmlYHi4YwFF3Crlv77FC6ouA2eZhJJrv1vtP94dnLD1UAtn4ay3MJwKI5zd
SlxMRMxg2IYlTYtOXdAFB21ccN4Ae9ORfwNTazBv3MLfWP7VA8oIQ4c1ucwyaFc/L2mthc8vbZJw
7qp0rbVKv65ariI2rNtCk1EryOXkzdDz1ERzZGlS7q2opUhAMOEGGkWYhtvfOsau7u/3/R9PTFq8
HnB8EBXcKj6fWF4OeZzWtXCurGl2WvxKlbnaUh+kK9Y2VMB5+9ZjRDz63MMsFPbkyWHGPEGX6vG4
xhcmvBTZ+Pr30/qHRQi7C1Y97h5xT0TafT6tuiPuaQrK4JL6Zn4308/qSrf2U5O4vdzf6v4SLpuY
gTNiyUlghW86elPqe02T3FjYjwUevJWrirmwCZo2o1bQP3IrnLxqykVnRCDx+4T/reChY/SjLpri
o70OHWLu96MoMYdiaP2f/+viiQzWo//zn//3X8PLL/FEz9/z7nvbfUooWv7Ff/uqiP+xIMomvgBA
Hr/Dhv7bV0X/D21h0qLBB9Hnyfv/vioCOUTgbCja4AggcjMW7el/RRQJMt+QOQRbooSTBtl88r/j
rHKNHS1OADRv4IfiMtlEePL5OYsH2UgQztSXHs+vF5ygoZoKoroWpjBHugiuFWLsdKCxk7dR3cX7
Ok/k70amQ3GOCnjqQlMdtdiY7wPVKldKgMyZisZYN6ZKkF88t+9/XN3Tv5aMP51Srtrc3yeMvk5a
0FkFKd9VaRLMIjPDMGku/oRVZUoEkkvWM46PcoNEh7SXGyvXb1zzj5XrXwfk0oCKyIswhnvx50g0
brTOpPhoLn1kic9qZd3rGar+MRMGpnHmS5KqCGAZU2wsA5Fz0pH5kKt96sbI4BhW98ekRf1GHYuI
BSjl0A9B49bYUjvihPK0sJikqZPK2IzBz1YJ5enG3na1tfEJqJ4QepN1T3KzfD1nnaVOV5Mpay8x
Cdy2lcGPnGIsxi2lSV2Sfy5iXDfwe7vL32/VNZS0HFhWmZwDUUvgWNcS6cUjKpvzsb0U/tTtJgEW
mxyU0T7rWhhSLWSNwRC6bRH4w4acAWGVzWBFpomf4r9/JhyfJkMjYYqB+tVNTGEsln5adRct15pN
nBbKwQzn/hB1VbuZNLU5dSRDeW0j1ltDi1tPbRIfaW94a3Z5jZss1wR0W0Qwjjxz4R19fpxKdUwk
Ebb8JZkKuHh+Ck986IaniidobUzp+FiPjWFHZH060pSXd7xNiUtUHkTKvvK3ndibD0MypC+yqsrH
tOn6Z2z+UuKTLeXW5vj1ZYOLAxtAlRfbni83UMkM7IHaRL6YxIccjbAqf4R4STpaHjXHEI92RxmR
5HT+lF/iUq93xD/ziE1zLnl4U4+eUuizx5dxmTVN7V4Asbxxa5f9+fPrCauT95IVURQN/VocIHRB
pQZ5rFzUqFHWMRH29ixHigMXRLZvPEX/cDnoyXiFDNbKRVr7+d6lVhxa4qjKl75SIc3hAwdnQV+c
2ZFfphEZl4KQPfa4VIsYnIki059hNLyom+KUtKK6hk8oRTKJDZbUjZ4RVJq+FzB2eunhJ/z8+9ku
K/fnC7Oc4RJCuoijUZ98PtlGq7UZAzzlkmawAGtyULxQJVpYbCcUeX2M+zzhnNtIMPNVpuLX+PfD
/67KPx2fMk+jpQfsZwjO9vL5+J2a4qtM2vJFkXrtLZ300d/1WdDgJEJUCrz4YPp/7J1Xc9xomqX/
ysTcowPeXOxGbMKkT7qkvUGQFAnvPX79PtDUThdTGnF6rrdD0SGVqohM4MNn3vec5yhIW0cQEyw7
nMTB0lvkG8VgZ1ex2GgvgLOn3GlLydpKfqmlVHZG/15RU+PdEql2GWOj7TnuE4qlJxOJXaFuopUz
xdB4j2pd7SjSBCYhEZnZHbk8Viz2oHGzrQPdh3jUVahHhzkB5US8NLyItpPn2SaNBHmtTAX1DG9b
g5QQaBVlpLRLflSFBC9bDhofUmUWQE40k+ZsQNVEiWBJ80eiLBXtgMzjyinVCfB9oLaJuEZiSFoN
6mOOWlZLRqsLb6dc0/KVcKX0c4nGT87o6c8pSidX6lPKfVNVR4kzdVJIjWlGES6SiYui368hxmRs
G5MjOh10g53RcMyI/CjTnLwpz7FeY4yyuiAh/7tGRz7VsuyvkUfEo1MlcyxsSxJRtoPY1gUYwCy8
KpvcBO0hD5po582QSs6fx8NlUYNDPOIb4n1Jafw5qVxMfBA2mwGSuXGnk+DHxj+A+dfpEBCEUn3h
DJBdizXfGSi/difLSvgD4u13DahfXmCLZunSZcfWrnJUvngnpKIISf5rjTshq5K1PJdgGgTA0X0A
L56osuGbL/3L5MT12PQtQnhL1/FnfX0HjDKep1YOiWYTomGThmniaEVgeKZFq/3P9/c3X01FHcJE
jVpDR67x9VLMsbGgDbN1VxdEMZEnE3iJILFPaeTAy2Qr9f58vd98NZYxNo7si9g2Ksvn+dvhMi9H
sM2jad0lM7a+uVJ1XtrkIxdT+ZuZ5HffzEIUshQ24NVdhpJXaiipfib6ZEVJxVYcCIYLSsHf9CwI
zlD74zdC/t+NVHp9aMVENnw6e/SvXy0rE9GIyJy5U1O52CRNTSBSlCZ3kslbmgNM87CbA5sZcw7U
KZkHVoJi/8+3d9n+f52+2fqriJvQ3ajEixsX+1zfknoY5IJ2N0UCU18lgGbcJlWF3z2NfGzu2pip
TGVkt4CZVlLs6C2DkD5Ubij3c4u0DuNL6mvffbDlPf06r0umuKDDlr0kcpmLgaYomZnElW/daVGn
2wRJbkvfyreI3qQ7JSdfhyA6AzQLsUmigJO1L6bh1Ouh/s0A/HVjzn6OrqjFsOcwRD/562Ni9qug
jZjJOW0z4R0+bfSkFcRzVKHS/ui4GfiBJyAhmBPS8VUumOawPpNS5FDzEzCENFbyELYYI2JFCx5i
KMrTajIEX0L0Xor3iswXJBvcAGTAUc03VnQ0uc1lqiqBHZUlrb8/P/RfRzpjnMKjtuCZ8HBevFNd
XbZj2XT+nRDSHij1Agr6rBNAEuadNyr1d+/w767HfWOci7pFKfdiP9MpqS5ms+7fWXK9SSlmUkdP
bucou6oRsXwzcH7zvKCjIHvnSCDjHVUuRrQsDQCeG1O4y001vYOmGV3JfhBSo4R6SBJTgMCjEWiP
ygDT6nagacy5QOnk94aZ+RjAIQYQ4PfrFFHNxop1jB+hReJDRvGuWYVTY26NugEcXVbzftKj6kmZ
eVH+9WfEcGPcL6HnbDm/jrqMrYPYwf1lm4cLGS3uSx/PP5pefktV0f3ztX6dY7lj8NeIJOfU9ov0
LlZyuRoaTbhThgCJVKa8wL4IbXQ6z3++0K8nNSZYxDYGQwF/L7X/r99q6KgRTRrtwyKs2pdqKuZX
RYOPvyrUEdsLUjHIdnnsNxEH7Z5KciC1+gtgVnCcmSQQHvfNB1oGw9dZhg+ECoHTBxVM1uqvH0jN
0TtnZR6cU72GriYUw3U74YsZavqAYtzQs6nE9NCpeAZNyzevOJaU3xhR1F8/A3C0hXu77F04rX39
DEMYx2aThiE9VZpQZWoMrhZN8TfL22+ugpgV4SFVIs4v4sVLnzd1g7NhjM5zAmAuZAPmRF3yPxi2
wH3xcSCsQnhnKV+/S1YX2GPlKD63DV7bXGjutEnZtgUMc6mbPv789ORfnx5nT5ZQql5LwMClQ2LK
dVkw6zI+s2JjNRbz4EBELowYHXWltAZrqZ1UgpYNx0/9LL6ZZZnGSF1K0/VQDbXozlY73adyaV33
plC8IUZUqXnalVGtSWhBDkkcsBDZWmvUmz9/9uX9/TrwqFgs5TiU4gi4L+F4utQL0JGG+NyIzS7W
Ed1XRnNfpOpe1NJ3WWqybyb9X1/y5YIWunSU6ew6Lka6FofJHDa48QZzhFk4gtfx006EMgkH5c/f
7XeXouaIN1FkIHCs/zoI0lwLMqWTkvNQInYL6VQ4g1Rrq4ksiG9G9e8utUimGQJQjZlZvl6qlmOM
Mw2LM/vf2JmrIljrdSJsQxmW+5+/1U/K0+Uj4xpUBCXmY9KVv15rDKU4UdS2OCdq1d2Yei0/BbNp
vOm5KD139BJ+4LgSjgHfVbUTMW/uw1pQqeYnCWhPrYuE+550PS+JawAlAxnp74Q0qImNxIQw9tKI
a9npJg1xez8P7cEvk3p2GJLK7MLpBZhLOqDKe6TGSD7Stn7WhVJ/q2tYa6tBIcXO7ut2DoAXLehg
QSQsRWgrYxuHU5YeAr0fD2ITEEYxB/rAyW6q4eEb6Ywzc4zDwc7mmcC5yBrlaS/CVgNrgE3tph4I
6UIt6+dE1xA5Pq9UvayehUwtjZXsh+GLSLpqg2GHTAO3IsYPWN8YD5/SECgsW1XnxQRE4Mku8Jms
hK7Er5xNU3EiYglDgURQH1v7oEd0kukJQMwotgj3g7U1o9Ybx1MiVfctQZMx/fRp2qdtKb78+eEq
y8R08XABLCJGo1LNvkG8KFDLSqpWCY24cxag+l9JjFUUTXEfj6sRXIfvSGQViJzGTTII6tFM3ny9
JjSmoqlzU/T1wIyhVMbjzJ4dO2zeip5sVnEIUWdstlBrlW1Oo+UhDXpt6dVGJ0IiCqySndKe+mro
Urc1lf4m0mPrvRlGSrlyNgzAlIm+/KgIIln4J6ls2kPYwjYMe336yGLZ/+6N+nnOubgTHCe5F7Tk
KWGKyyv3txNXbJE9rSp5fSY0xHonh5ZluG66GIZRX0LaKbII5OAckg6/msSyFNcEoLUtNvwBYacq
ZYVnFUq6K60KTqfSCsobnKkQTb2BzNop6krWwW+Jzy3Bt4i3KjU/8r3KHucoG3koZhFROwlhhL7d
khqrrNSMQMWWp7CqmkjXt39+9L/OxDQuOQQZSLJxk1+eMMuuiA0fGddZHGXBk6zc35GI/M7nLt3Q
nIy9QTz8N3PJr9MW9XFlKVtBMQSocrlH1SyyUogpOUuUrp2qrH0PyCfe5HqY7v789X5d9znaLaVE
RNVIYi9lBnUviUohxdU5kJIQeEmDfGeEsvPnqyyrx9dBw1WWmqW03ESu83XQUEXWWi2sqvOowihv
SH4NOwEyjQ/IJGwn6LOcNAh4Hd0/X/c351eaUwqHaLT0FLsvJ+VJUssoM4zm3LD3eBWNWTwahRge
J4MExGIWpOsyAdKlMwOivEzMEwVT6yMOQzDqdeZ/s6r/9uPw3kAzXhpqvyzrbd+yhUzJoxpLaVyr
UXaW6xpwsdYNb1MZMsZFc7oxCbb3ahKd1uM89TeZn4g7uYzyb3a3v3n0iOhl7M0YeigyXGz5oAHV
OW3b5jxUaBqzCiUa6R7WN2NZ/s0LxHbSogQLPYfC0MVgJipT6oaoH84RqpCjGPTTOwxtds5Wqrbu
4nuGLiIEpPgVarPL+KyTC9QSUF4ldlBOyQRhNSIJCPGeKXS1ua2CAJF26GPH7RBbd46mC8qAlawK
dazMcrMnHGfKloDJCe992KPcrbNae/ejVrLllswYeyaCpvhmY/NLV4VKBEONm4kABrW7vqwif5sb
O8nsid2dxrNFm41IuYalM2mUaltBaWkp5qxzBXE4T+R+hqx+n+UyaAxZ1ABaw2PJgniiblEVu9HP
e68IG2k3BD6a4EEcvzlVXCIyzOWzUs1CXK2LSHX0i12YNUl61JbaeA5EY3pIq7G3pxS9AcDB1HLr
JhYQQ4qbOcZBglxVvRXmUdg2ZlnsKiOwruTQap9jDdP3n1/Zy7lv+VzLu8ErK+NzvXRIllhcG03P
p3OVo54uq6jfd3Kfrsxu+k5l/rtLMR5NrKY/N6MXj4sIOIWMbJm876giyVnEQzcofrbuCKP7ZgK8
fAmWb0XzA4Ehb5zOGP46MjA4CL5GECepMHjleyNEPTSglgjiCm9imphHSWdn8+dbeVlYWS6KUwD5
GH0PC7//14tKxHRGutFz0Uol71YeQTSpo+D2AUUpsQq/qzP/Mr1xQUY9lnQmFVFULo+qBCmkbdO1
4jlrrMlT2KGM0Nai8FD2kNDQNVVrcekozKNGUaSX7vu66O5LJSOaNg/qb4b4b+45j3ZhG5jLbV/k
EF/extISeLdU8UzNMrERZ4+3hJeDTh8yyatqeXS1cZi+uee/mwOQWfCoUQXwv8v3yqxVJZFLcz5r
viDsSbPNV4kaVU4xBi3tx8pyyVjkSFrnqSeSD3Zu6L/BsiaotRvao0DPg4R5VbzpSqHdCkSMHdju
F06lC9+ZkX8z/umO0YpAdEFQzuWmdk5ohiRGMZ/rEHBjXHQY2ufI8uq+Kb95qy83AIwMdhlsoBWG
BjVl+euzKKSRCVhNpbNqdPOWVsW0TSeUbPAvlVVAOBsHjWJ0Rz9pv9m/LU/571sPduv0WYDMQ8Sh
/3f5JZcMOQrQ1nzW+0nctbU8Xfux8PrnN+3Xr4d0a2FqssehVf2zlv+3iX8a04xzbiqeCarPnJ4/
PhI1gSVMLcjNasqRvLQMfHzQ9t/scH7SnC++388D+7JbxMd4abua+oAU10iRz+WsTg5Ze+ptpvmI
/0Krk2GcqZCwHVxhC4ArYOfcFh0IuBbRL2BPMSPEERGyaJdmrxAqSFjovdyE2mak/18TvTLzk9TY
OkGDrEVnzqf5c5Q1bCtIB+c7U4+6O/R0zxo56tdmjXzBYxgEkHRMQ/lUZ63YWwhK5l0bGcGIsiE2
n/poNNe5nvmIUGF1P+oltMBV0BTCKbWMQlgp6Faqb7YhPysmX+6TCcvlZwQIGRvs5y+2oGbaL+04
PbmPG7HaJ7ksdk6sFePBmKI0cNH3VvKVQOsCkpqhZjeZkceiXfgZoF4laqbOHkFVQ3SvFDCbfksK
tN2r1auQdfHSuZVNvHdpJKzGPMc0kfdIwenJZ8WexG60E9O4xHxmWYXEnMSqwLPkVttNlh+0K4lU
byis9FqwtKtmf1JhHXxTXP3l4MbgRAFDuZioAEqJ2sV2rxCIrx2Utro3lDDcl2XWbSQtLiI7DvSc
HEq/ILgww+J24lgTb4IhxSVUdXoBs6cSsCgWhHCRXjSFCjF1MxigYEwsN+0rC8sKZnHNUel2HM3K
pN9sAMFY+FFD+KbSnGpdkxxkgIgUUGw/N+qrZJAoNGb6rLbeEgHyzYl9OZB/fdxU/OjzIshg4eP9
/zrh0MQo+yQgmqnvK1KsWV3AQykBPNPIUtecUTDHasRTi0GokiuRJdU3884vxWyYyVj1sSVRTpHw
8l6svmqXdCTGRP29pREnkxQ4rwqjTTat2Goku2rdVhiSZl2YMotxSuzHUOjxTWhk0/rPk9MlxoR7
j3HvZ5cKHcaiwfp6L3pxjJQ8L8b7KRvaZ0MaTGRzbagldpKQhWUHpUYTaZRL+WkWZw5GgZEEV7lB
1rqXTml7kyk9GuJkSv/jIf1/uea/0zZbXIt/e1C/SDYJDipq4fDRtB9/l23+53/5l3RTNv6BJlwC
RcTeis0VK+df0k1Z/QfOCJQ1FmpmDJMs739F4gnmP5Sl5M2Su4jN0Koz/P+fdNP6B+gRBOw43xf5
IrKlf0W6afx0xvzzTVtqIrQJ+YksPyATWPy+ji5VVrusV0q2L2M/PZq5ypkt0vPxM007grFzxLoO
EzMw0kCeLG8KWEdGoUSvXnYWDUxqfmVsJq4PNmk7F3X4KGKbhrfdIaXMC1N8Ggc//DGobYMnSvY/
e6KvgZfpYexKZQ66qAxxFdi4Z8LrNq7xZelDVa3EWq63hZXPx7wr+EyZ1YTXhWGAms8N/V2P/ezU
CR0nX1VNXJT/qSd3tT20Ia4SVa1vNCWFSTIiNx66jviZLhTOuaUUr9rAp/CLEO/YsGwy7Qons8yX
DvgnhM37NeHLKFCHadZ/RKw6Hz8/S+MbqPlqRQtNVxyodaehON9MGr8bxz66KYxKOFfNKG57K034
qTDIVNcPOsJ56ywoHC2J5qPRGsVhNowROErdhz/ETuLLESbPFym04Ekp9cQR9cJ0GjI1IchVTQUd
aK6OVCsb2HExJ814rGxhRkFEoTiSb+ekJhyC5tsZrlf5HGmF/yyN0lgQiiJMI9alOdeuKSbOR1Md
/J0VS7I9q4FKXrCWdy6ifaKXAh6iOUEK1MsColzUZWDF87x6lGSwkEIj+2eCEbLWIUSRICsifytq
hh38ZrFKbrV+SGB7Zb364PdZeD0kckooca2AmDLUsXlEH6y9xKVobJqSJx2OfXOWJF947P0k2Bhz
Y20TFDSuj6J9C7TC3xnNKNtyp5/LVp9fNH1Qf9A402QClpTmatQ1j6qI9QwyZTyNA0f0qVOHKwON
IA97FmiDmNm1Khak/CWTtpXEQX7Gj54QltD5z0OXIOXS6SzYgZE2SJzEaR8seQGS1HsznofTGMXm
kZN+8cTmX3yqwnC6j4JMvxZ7Et5rk39FTdTkAeEVnk0f2rhpDFBuxLp1i0ES4G9nMtogcgnUdKq3
VTxzShf0hBpd3d+z0yBdBgTP1Pe5GxWj8kqeEqb10G+pLDeY8BryT3a5pYdwdIhQtSU/K591C7qs
mArTUSul4DrDYfMys1Svh3rqqY/wbsoKANF2rpNjpwTJUUnr6CaVZryqEXIAaW6jtUo6gdNqKL4q
vdP2QdTmILAa85gCNIDBmiOLSfl5/WDkd7q/JIvLnXgddkZ9HRJ1hpo0FR3CkZ+syYrwurB3UOQp
+0ytfDzp7RQefRQp4POjaa0n1CeaOBbJmI2SY0oMe7CaFAg0U2RE5DjoqceGJQA88NMRRqJrVwFo
rotNGDTjqZJ4TSXYfaGdDDiLZHajJLpFrXEdkEeDwYYH8cOqZIawXDJ0ikDGcy2J1JYQyFbZdNTn
VnT9gfQWMpuRDG774BargRs3uZcZ/kaEZRij3SB4sU2ztTXmq8W+0Zf8WJyEe1P/YUhXSbDWQox7
fbehVg3LdR/Pr5zsqiX3B05sfBsra6JjGwrqhX+vsS1USIdPDlWzyUdjOaDZlm/3wnVev+bjPZY8
d8y2cnEVj29TGkIAc+No35fzqrMk3Ks3vby3olObkLvoQnxPy0MeR64pjK+j7tVBMq3ALBBVvkEJ
0ZWe0Hqcx8Awdf2pKAtoqWSx27EWbRPiplMHgBv11NvgrTQ2Urdpi1tlcPJisBNruzikxesk11al
4UQZaON3U97ETM5daq4oqizxvBHfLOjYTb76VeTVMINDy/BqeW+Gj379pqQvEkRZfyFl99tA8slN
T3F8FZLjJ926U7sfY9xgoVRWLH9e1o+rmOyLvgKtkeqvei4BSLmNtM8RBWREwrgsRY1d3ZrJTg2L
7qWmV7jVVQHUAx0MwWmHQdyUZtg+whiDz4ssNdV6p7SUHZWFg9CjhpSLGkxuqdhKIpxDERJ+oECV
z0qnQoBL8LhjmWR7D/nKpzGiRBokAP1GkysBxm/zLsOQmWb1NEfTI62QY1rrD5mMAd/PxydL6w9d
OjsNS54cEwplAtU0UkKtdYXKaCQrn/MwPEFzf1fIYUy021w3nxMNOL6gnEtCjZXIfKiiV5F/GxcE
M4jd69BN8667mgBj6vlxuYvGQFxcW9vVMG7kodpXcyivWmjaAvTNVp5XUt7jDb7qaYFndHBMP9s0
gGKrPHY05J4Gqxap4lBOtlLOYNuk1UdZC+s+f0PS6o0h6UaCtiuJL0BXCEdbYkXfadKWQYKZPumJ
4pDeyihy0tZ/94XkUOZ1xHH0R0iCy5Tq7jy8AWlYkaht4PYdMVsG3pzvVfUNNoqra7fot4uJbDPz
edKitURxqZMYBuFs1St/rKeDNg/5bohkvpkhT7U7I1jnLeI4olX1xkApzT2PFTdv1epUWdlN3bUr
34SGUiheJMfHeLbeZAQCVfe8cAXsbhI2gwTKPkbu6Aa5cQfD2zb9tzjbdfl1QkwYWNzJfFOMM5I4
GS0t3upi8Pr4va7LAxqmXjnn8dEM3Sx/ypqj6AfuxDEcC/FV1e1M/8AoxLOxzd6g2du1uYaW3Oaf
oSFRFSfvdNjp9W1HEZbsFxpiW1Q6UKXNHzRUvLxb8qm3UvyQaU8oWQdtm5sFO51sb/h35JO2YCFL
xZMMpwncQoa71tiCVogvVixOz5kO01tBD5wfSp/otxZo7mNUr6D2t1jxwum6ttYz/GkdZ+AYrI1g
sYFfBUCEwXGtCLsZSZDMpSfBd8cPwf/siu3sf1YtR/qtLL5V3b6rzpH6MJDWMG/CvrbDkLQ+Av0a
LPfnXHxS7ifpGgPZqmu2Cj+sS8/EP4zZTmw4na7icp/BQErPrTi8JLBXeGwkhrC46S3Reh9Wsgcr
mRXO3Lip9uHHu5pUEbYuGzm+Hfkt6xNe/70sVIdYAXBdsU0Ln+VEWwW+sCLoYozdXnNY3VR5Wmli
Z5M70YzxSraelWFjGC6bza3enNpx1zNVgZjvYfSGjTOE+0Ij6kkeViU8uuw4M+XW5kHsPofuoecN
Epp1Vuzq/hnTtpRuhgH6AWDcAj3TgC2XUo4tpBtzBF9fp+h+jbUg0Pa1VlFMWke1E/UPoKsUagF/
82GLCXVZcNbqa8619EWRSbOnRgRIZlt+SkAzpPUhGkan7TvA2+QNlYNr9OeZKF6xdDEl3czmZ2/E
K6Nzo26TlRVrFf0Gtt/bToq93DqFlccwy4Nw1SRXKfuxJSR9GPJHsbrDsbNqo9Tu2RaGAVjTaEk2
FPIOacJE74DTJCzk7irNEqKbbvTkJZ9vqAq4TYTkn5S64TMt79Gpyjjh02Aj6kc5JFH4ZV7AB/o3
dTEqG5w7Ls4lnMEWNBVYqiVV/Ou5RJPCMlCkIsWF6DNi43pIHZo2cupEVsXYioocl3Qut/lVrU6Q
iKAm9S9VhO1HE0f9oOdsWXqKi5sil/qnElk5zpi2e9LiaFhHQgtEo0zlR+Qep3JYkP2CLt/xkwPS
WGfBvNIBH121XVRv2rxRAaeLiAk77n9TxxNWiJhnaqX9Hh0HFQBLeTHbu7qQd2XGOzgvmzV6YPXQ
eq2lnwwp+xE1450Z4RlgE72a8soJ43VKjqGCMoh7XxjEO3RGWe4CaTwQ/CfaQe9vKPIxqTagtrPJ
s8TAFqoK8eKn0cztOqP006/kbh5OYQmxRpy3hsUeZnnLj5S2jnpBc/RlEu9lKCaJQnKPeWyz22DK
9lOtouqQeZIJ+BGt7KhsO5rFuxOeU5+9f3mVpvlRrgNXIcqpydZBM4BwxFFg5fHWYg3R4Sd4fX7f
8iTwdc9uOzEl3sxt82OOTooqXE/qaxa2uHP9m5QImGbT5VshnB6lYfCabFHPg1Xo9XWf5JtSZCBV
7R7VzZ0E+QPpyqoPWQFjOiAJwT3+C5qKvTLeStWnPj9IoekYxT14X5TWCFtYkf92oL/+j8H2d5fg
ZUNkkbPin6TLRgI9J4NLiPQsanVaa1W/j43h0epn0dbK9FDX3Qv7zfmYIB5eY00D6N8EJXsnoPzs
NUQvKNW/WDn/Uq2F7hK//uiL/e+5Z9cfxek1+2guf9Tyaf7TY9v8759/TTD7Uvv48gdWWGAaN91H
Pd1+NF3a/t3Y+t/9y3/7+PlTzlP58b/+/b3o8nb5aQHv7d/rKZJGQeK/Ns4eX99fi3+7+z+3v/w3
f9VfcMFiMMA6AQqOAEOdsulf9Rf+hhwaCiLUx6XFDPqf9RdZ/gcQEcouFl5upp6FNvJX+YW/WmYk
BgMNIl2nOPmvVF8uSnsCV6HhgEb1oqQXJKNZVhYDy+gpEVinpFDuR+U4cApbDdc+nNbBf+x6b9i3
+SGxlG+KyT87ef+cXP953YsishiqTSs3Rb/v8cl3u1S6A8F3yoN73qWNWMn2FXvMVz8tHR2qQGOM
G6PYCaLbqbdYHCmx22KKR3z+EJdNRJrDFi/tQr+iHAL/ytwY4IDM5LljMcmDfaei8Brf/vZ8f/NS
spH+sjL888NfrAi4XvssDsJ+n0TbUfyItbc04rDhqhMI6/xZI7umfM+lTwPe17ukc3J05iUygRMS
+D1EoRaZO+lJIB+GP2XUTIt5M8sHST4cW2EHr9hI7hMLAVjGAXrX+6uBqCl2XuOueKk+E/ozMMrC
bbHhLHfMCQNckVTiiU7lEbK18QnSKYmi6tzRgUKz0g5QlleBG7imE9lEejuJm18Jqzdjla0aF+Z/
eIgP8mS3qlv4j3iGbUP25PQsD6eRg2C19aVnvTyl6X0+7jLRxZGRUAsaRBffpoXMM2nYaOTotDSH
PW7TX4mlZy6hds6U7l4afVXskmqlRVdAm6pbQbGNZoOYkASatvC0RvSIsG7J8MA2h++tUm6S6apK
Hao9hr5J6zMXJBOvrSVHIuik9OEj7dTqMGQntX2o8l0ybVhepXKjhxtJ3Yz9NSwLM9hJ9In7rdL/
oPngyAvPdoNsLOEX64Q23YaDvyJEoUA8uRFVt3wLne4e36WW3IbzUTummqfS+XJTy9FuWXMg6pTu
WNrtg6Ae9Qb94eTAS+Hcyy9pV4CQgn1VgfCKngdO5ezp+lf1XXyHNt/Gdr7EFZgj9HEyL3WHn8aA
kW5Hw/bZNpeVrb8X/pX5pobpMzUQbmyjb4VxM9xFT6PcehXWykEn3yI4Nf56WsRIlT1LNIY57vkq
JQkeu0AcmSMV+4x4lCl61WW8mzaJ1ljpdiizRsOhShAT4G2Q1rRRjD1dJuVh5v8sVybt3aFCFU0P
HXk2SnLS9V0LnK73Ko8dK/E6ikvg5b21kXdQ2j0qX64FggWp4Tp5Q23451dMWqaB300PFy33UZdY
rE2r2wt36bW/I4yJ/B/lRJTPLj+Np3yXH6Xr7Dun1Nfu6z/f5wv9RjzWiiomXC0/dA/Vqb4e74oX
ePdrmNWn+kS8013u1kfzVPxPr8i8/ndJgTwhhx1Cs9tLV+LO3+kP85ak5yvifg7mlbbD/nzQN/Kj
eVLO39xRVCn/xT29qK/36dBxoNG6vXJVVQRDrBTGF1Ffj9Yp2o1bfZeeqXSEZGU+TDtpW204SXvJ
hldgRy7Hjn/m1Y6ybXb5wXpXPHhg1+1V6UX7/DpCuw47ttmE/rG1ViMhWJEzYzV1KEepgwcqLuDY
S2JAviR3JZNttNTC3FB2AOXBeJaPFjnqb1JuDzcR9DYZt+eqmshZsSnOu/pqNoCA2odT4d0YQMIT
r5u2cHa1p/IAHw9T1Hho+xsRPlHlle2aVFip2QUna9j7zYENH65IWsHTJw5c6rHNA9Wq6XOhuXWw
91f6p85ZhNL+OrsRj+SCIrYwX6vb6mTtzw0a/SWRSUPyBUXo2G6IVUFI1D3VlA6vJ5q4XkbggGZ3
XHLLBa7wxsKlcePKNp1SWxMHStQ8nCfEgUa76QLPlNcVJ//qw2L2LcpP6ylp3tPyuVUe5PwzELe4
RMx4M77Lx2EvPCcC6SaOpDoxG+1dGWwIiq8/xLf4qGyjz4ZmcurU78Hb/ExhpY9pi6yyt/FavHmg
9hAU+zF56YnRy5yao6K+4TcA42pMvymnp+U3oNgZEM2n0a3m9+g0udEm2FQPSnVjqcs6opC0tLI2
zX6i470aHvVb8Va8SbfhWXliu77iZMYruWS+d3bNS9Q6P8hNdHQvcYIr65q7L5F+HuIVtgM4l4wV
2SGp3aJus1Wc1EvW+UY7UmhZqfbsyTcDSnPbdGm1usmJCE10BYfeGz3rSvwMr/eBE6/g7Tk8qNXA
5WPb2KZPlWtddQ+0injCZJQh6HXxWbnYqFzfg+mJdmBVbnEK2JyAlchh5caW9jhdSafgpUnWrXUT
UMWYHhreg+C8yMaKtFiRojLlb+KHta9uy+f6mUFAcElFqydeI5yvm42JHtlleGqgkVeaHXyKXk4d
/T7d64Lgmf3WzNctB+7ADq8kKrvFPRpj/lN+ADUi+BXSrTjdmamn3IjEJrGU3mqmp9yKW+Gmfo1P
2k31JN1MV+ZBIH4pc5WD7FZ2YiPTWOFGWJ11O9gUt8KT4WmH5WYKdmj7u5d2a/Fvx15l505OhlBy
NOxy9SzZutedda9dh+60qbzn0X4fXdObDsmPmAjm5/Y1uk5P/l33RKVl5CtRNr1OdmTnLj9NXUm7
ecea5WB2a1bqa6KsW3ICczusHKj1zeBKbxL5vo7oJjoi/n1vwYuC3s/CL1a2OrO9oN9xy7gbWYMj
N4fmy/BaUTHw+j1vm/ojRsv5RMzRz3o30cRFb0v5jFlxpXvNXXkkxqGf1gmvrCOsiwNvIgmgB2iN
ZQh/8KC5wim4iYSH4sXw2gMJd2NnZ5kzfA6VXVJgZuDLR6FfN7CfRztSvNFCSO9qjZ28qG6wUXeK
F7Nb0rfSo/SobFS33arEDqzTZit53WnedqfqpO+yB7RZ1xTH3/8vdWey3DqSpelXyQcoRGFwTFvO
gyiREjVuYNLVlcMBxzzj6ftjZKR1ptVgXYs2697EIq6RAgGH+zn/+QfbBRjfNRAbqhVvZDOBJ25s
xmP9IvnFYCC7wEcnA8UoFtiZVcFK6r0ycURfqB4k4S5IAbkWQ7dqRiaGu7o5kjYFy4xer7IbAKiF
r1c24cHT/Tit5y246DAeytf8KT3iEXzXEN5dvtjWe+l/hemHZ7z66EbS94ZBF3p/0oBIly4WzVVO
P0ZCyt86edYXPbZXTOm/fOLLWsCYYGGbt51y2CUn0CsK1JiAhWCNDwWxMPBn42/jrb/25/C117d0
wKr6wKvmzicHuST8LCXXAWOZNTYI1e/sd/DuP9rnW85Whi9kR72nF9Gv9lO+t4/9BevQ4ayHdmt6
PSG8ZFeWq9iiJrRpv6udbpeR+pAYbIHFD5T55aKNl4V6Zr4bp3udrxQlVP2YG3LZPgW/229U21TN
wJ8pWPh9+yDePdLHd930JgzSVhlmMcnbW8DFE3sEU5DpU6mHvse4AC7ZTsuNeCy+k+jY5zusI8un
4MXsv9Lme7L2xlv20r6Ji8mKIySwKhqqt4MXLEF6uxWgOwAYYptlgY0mKUb9y0z2Xb5RmLOS5QPn
f0GemI82pqQUlp48hc23A0SEp0G5AmFj6lM5+/gZS4U1PMtF+4p7xMkdICIvMAAhFZgTplJbL3yE
dphHR6c94/FSOg+dsaUzqo9UzxjWendilz5UT9EGj9P4xY2XHRrrapl1S2C+clr12aItKfXWE4gj
QX0UonIt+qOZbvJsPYj12D/PGSuMaM93Tjd+GuDyKrxEv+Q3KAj5jPFLmZ+n7N0jSizu4HYQ673v
xcadqHFXVJmD3JoOIo0Feh2ce7PfYHlxw0TzcQ4vbnvE44J9jmea/PRYvp7tu/YysfaIeaw/MTXW
0V0mvkJMYmgAXdjCB3o7q35WNc7zgFYhRBjS4sYFo5NkJMl55VpHJzmO+stCAeRhwdZ5ELBuqYgv
2Qh0M36r6Mqx6VPAtBvjYXphb7z4RAHx1htHp7t3u/v0ItbqMf10H8o3p/jQb3hCFq/qqXhwniM8
Dqz25TZO2zcroJ+PM3vSul2Wz6hIq3VZ0WnFehkz6y92ebouOZ3kEtrbxEw33AUDmSOYGOfDarJe
uyQn/MhamH2/NPcTp952XqfnGiBs2k1fsrjYT9iWZn26jGlPhvzaPQGWeu0ieIX8fq3OBBmXM/Tz
NV0H00iay/Ey/MJA14d6TZqSWvd6z5APO40NCzL9Rb7qXdItxat/JV/vrN1lsi2iFWHkuDunT+1H
EC2UuTHsbVgefXGty6MSS0YifrbGCAqfoR0aki/YiPqZ2VBw7J7yi/7NPHQ8scLJZi6ow6AQfKmf
5G58B7kmEtJ7ju/S1+ge8Nhw0DgtLYnYeTF/V6+38Di5xGKawoaMNoKaCLCpOL4ZaW/MRx4zEa+2
ufw3NSFxKqK0PyoCrBcGm5HZkV0fJBfjzVuK55joJxjyv71kFXZLy7xPmpNBMnV0IPuAIvfFHm+p
uuVmIFMuZsYNRdo0hy1zp4Uw3q3qkwnreuiykxbTmnY6tN6GGv/A4ufP8vt/BJ79nyFj95+9yn+K
/y+AMUyo/qkL+Q8EpYcG25X+b/u2q7vyb//+t3Vb1EXb/W3f6M/8+1/xsj+/6i/ETAR/BKHtw7GE
ZQnx9n8jZsL7AzIaUkx4eT4UaRq5vxhLwv0Dk6CbDR3aCdDSmwPcX4iZEH8gE0XFC8x18/iGwfsP
tPAvtAeg8e+2eP8J+kP40b/0UXyNC2bH38LKNbgx1W991j9xdcspg5JkaO+5dq3vvNcEDpoo0WoU
sKeC/J417sM/cYW9YRr4eB5mhB/HxFGa7ALK6k9dPAnYSNVNdz+HOHW31L2RXV0avODvsykY9/5Y
t49RYudb4Wj3wUwy90HDul+IObtresofX4/NasZtYC3hTB67OfqlTeeCVQucyLx6y2Ir3dh+y1li
So4xPO1HIwowzSyfMjwK4NG+W71zKUuhdrbXlOsh74m092e4Kxm25DrBvFx/RFk0LvD/SZbmEFyR
X9M4WgZNkW4r2oiZ5E9zpoabko8wnV/sSj7bcfZRyJAc5DLY25nxGVv+XnT6h1CECncVca8YzNqG
U++dAjDfsZvXqQYhslFOv+Fo86Ws4NpMN3fRECIIcm/czL37iKwKs/Oxqs6Z7Sd5fIw7/O4NfABW
UQUpzEoCgnStOcccqi83XczVJZaPwnI0XyLJZeqMs8DT3sIylLfIHW4WhmU/kY3zXhuaL2ZWT9up
b5olAs127Uv+M4jk28ceEB0Rv9usVPkQ2dJbRj72orWbn5t5NNGRUsmaGVQf6ZjE7aq82wkMmD+G
0o3eZOLHm84kh1v3Oj5TQQlQIMaRVsmxMpKQHHYkeja1FBjKzfU+rIRaNlXK2I1YhWWi+Ptoz8ov
gkKst65kBcCHnqmp8W2t5rpZeab6NrS4hL5xsAZ+tA8nf2kU8U9uxD/KkT+qHGyS8PK7YhoDDFu5
RdJnAoMfYrQ3RybVCivQNctE4cEiTRi85aOfkpfQlJa7m6BSLbo6Ybw4i+qAqyg97oRNWtr3p1Yr
6t48FzdfBcoce3rpg1hsESQH+Pj29T5pp/QQ5Ldio1HOq0ZlxfSQBYYz73Y2h5fIoJzwmz7mSPcv
jYhuI1bXocn37knLcO9VKapfuUEWQhnAP2LEcYk7fBNwSrqkRfI9JONLUnHdaVnMp3Iwxuesq/DJ
b1lFssPD2Jnzq+f1VJnaUDvf41tKVUCEAXhUFdXCOPAUhdNiig+FnMTv6BpVyZcxl095x9MvEu5B
Wjbh8s97npdAgWxgFwPuA2Svlrqmio9DWp7NoT/1nr6zFNYB85yXyyjhTfILn/zinMXekP6zcEdA
ArsAxi1Yuq7FejSMQd6FWbAPc5PFXeTnyvHVZU7IqOBpLuqpfCM5kNOy98aFUzBdbIsnM+fxjTMo
cTO/SPz3kM7aL1HLOpmGHN//LCBMGShf11ipK9mpLXpAlp0AEUQkzRsBdeLamKkPhcyMYLyxvyRV
RjMduGtt1Gsl+O212Z1koO/mkuv1p/Da2OW56FlPsIbvK1QCC3Pgr8dxRpT4YM47S2KB4tttz8A3
IY+iO1VYtKwcW2bLaiSSLTGZTbc1NgiZV0Uff+5/RZPRQObaX09SecvaZBXpaH4xvIkBQIt7u8tD
WnpVXC4ti2dcaWILBXzqpafVV2NTrhvuuICvXzzkGX1mMPvjylTgOypwjLVpmEABFczJzOCJFLVF
0yN7hDfwVrglhcW/y6KlkmohxOEPgk9bVb/lVv1mZNj++x1b/hTSzo2YBvo1s3DCZ5rH9PYgMxev
aeS+a0NlwYo99SX1WD15E1yjnlPA5GLocAl5izkpyuhTePFP5g7QTTXZ4n7Zt+s/vzt3bLiYs4uR
r3+N0lmu685MV+mcfk095LemyBqYGbcORFekBQ+EP7SDs83j6SVSyY/dKH85R6Z1CPvh9CeHbUB/
TlwnvLAi1nfVBDEs4/Mce/dhM5ycKBqJaOBYgibycSPX1V1mH9qA/sw05pey8aB29SxEpFwTZIeu
im9mUuDgeWgkFSbSBu1Gk8z1KexS1po5wSvpbbUce2DN0rn0w409KEsIAflHZSTP2DCRxxKzFtIK
SqDf8WhFVN2wI7Yid4YeBTMLZa3UOz3n7ZOTlv7abpNyaRs8S5vjYOyaN10N6WGwku/S0iBIHcTK
AfrpcvAYpsDJAtuyxUgkQGBdLew+YBY6Lj764jI4abh1tRHuGckR45MTPd2UPNvIuxbazBbYY3OP
DdZL08Y/c58/zaI4j276MXJZS5T3AWIQ9SUnPirt/A4i34vRevc9jfI2sXvkwChIUKbwQFtZv2Wz
hruccCdQ3PwOJf9bS3+fh/qDdfCWjyxqX/jXMAvhOsHSDbDTs+2Z3VsNZNJPc/QYjflZp9OL1OVb
1MCUJFezPjl5RYJXg7Ve6Bm/OWlIQC3Uj2FCzKuynNo7yz4sAyZm6WnU/vLbkLdbXxAe4pYxnLec
nnUYG2jTsEqV5BotbnM/ReHeQOo5FjB406Av1sWI6YmRSo5SSx49E37zME3puhY1l+Cm33qUP+hW
Nm0rv9OOXabEinRnlLrYTWXkLh3GgYtg4KwbVEzWhAgQNZskEVQulDen4sFyYMWsluHG0hm4SUby
Eyrettrg2eEAMS+Vxztjdeqrd4xDhshqGWbGtXPZyjtimhYz8/OF67E5YzJAui5RukCiA+6G7Ab5
BFnX9LC0/JO7ioS6WPWtpIewzQLWnnCj6YTIXTDs527Ilk3Xxb2I+U+hvlyHk7c19LnMHaITTXLt
HX56mMDqc4zxJcWYdeGm/P0yJ+8YAeM1RpnXKoyewrnG88flxZgrlNq1nst72VoNDo1x/HDjsB5u
OyXg8vii8iD6rHuPH6Obt1t91yhwA5UOeODPiIPIG4RrnVPUlDZbjo0edeOrAj/hhn02MiO6MArB
ta31HQlrn8WUuqukLz6yQnUb6uZtO7T2GjOob5U2LD+2qzRl98f7jBRISeXoRJgLupNXn8zCdzaY
OtrrWBDRbTjskMmNN2xDY7lxrfUiQRS2Nvq6vx+qsl30rnkx8Qd2pG3dKZ+3puVmenk0gYKW537g
+iZT36wvaXpnBX00Y/YL1YrbbTrqq87YdjSqUKpl90Zl4pMBWviltKD/az9+6g27wx+ShZoKqL72
7XzxHPldlOmHHMJp2d9K7Fhn3ql1FMYYXpiu4hzicDRmA+OI4BrEDuU0tJ3FOFt7WUPGd/vt/BXV
NlieMxlf0uQwE2VGcLrBi64jMe7/3AyVgN0oI/uQxe5Pm/dwaAs8qCl6XnqocbthtMkyjxy4sH3K
sevqcNO3rGAkj5C+YWhTEMQ/eLs0jDQkA+PJv84N9fI4x7B6lSdWyh5RcdacREkychtTzzmYcdz+
Xe3zf6FV/S8b2v8nWRyMEv8bFkeRy0Krz39tSvnIP0gc4R+hYyOkR5b8F1Xj7ySOwP+DzEIaTvQy
2KObN+Pev1pSF6YGMrmQ5DP60cCHLfCPjtT6A42/ibyMlhRXWeH/TzpSGy3Pv7ak/HUMEnBYw4GL
q/izl/7nlhQxYUH+uZ+dYhHf1ASiBUEZazvTeCCkHOtNmiWKzIyyyiAXjjYps6tZpXEBdBjYRvmc
FOFg/vZiK4B3Vno9L6Y3DV92ZWX+ZxpGBWV1kgnvk+p3sBZF5fTzJpHNPB8aaHA0Nomb5ps0FPWq
sWv0mEZLxoRZJSbxulPc4nFSlrVlnafUKdtl6sxeQ0lgqKtu4FgmbjVAWm/acjh7rZ1nd0Yo9GPf
9p65J/JBK9izaXPBoFi8pJhMG0gfUR++ijlxMklkUdfsDDTyIlmnKBUJhMhuQSyLfGgydbJk7e48
L0UrGI0hNHMKRo+2rR4RXz7NjfChLA5tFXx7pRHc2YnVj8tBOx3AXd/14JIoMddRD5V3Ued5m58a
nRHuNfZu4dTUXOaU7uYB4OBI523Oa8whsvYtQ4Ti38s4VPHert2i2UmrtJtvCDUlPoH4MrEvd4P+
kHPZ9pD5jeHBKhzGAwH2p+p59sk/zMjEoNIJyumXJ4Zm27nNuLWylmCvObHFdTBbv9oEmTRWptAa
rwjpwu+UbkmAXTyiVF0m0WDEUL8jafxWqgR61bnIx1Wetm67kFkz37CIwSaw0FPoyFgUNSfITBnH
mdQRI5RBcHLuvH5I2JuxqlI4ezXudOOATF4HlqgmBFELQkf7elPkMwDj2HClSP885BCi7XW/Sivb
2PljwoBvKBgQsPKYNGtZtVfbH+FBrqfcMrqnDG/OadsF2JeCaw9TURNxV8oCk55M3BYL7b0rV7GT
dUDNocxm5gFN0AztvQ4yK32tHJG7UFyjkOQb4dnBLoi9ODR3keiC4LuXUSr2AwTCyWVMlxIR2w+T
ozdWYkXdxjOoIlZ9OLUDYGTQ3s1WP4h31B+d8zqUJjh3nxOGCjFi7LIKSoVFY7HOaR+cZzFQoR8K
tFDeKox8Ji9un0fZXo5IWc+wMJ2Z1Z/W2O4XfeaS4ZbDtvwQThzEhJuNQ/fUdhlI8pQHfbNGTxzJ
VdQL+iPaqdEnB1uljHFGSEfrkfKBEZGZK7WLuqaEuY9ZvbzJa2usQeugy3FV7YqQ4avFL59Wo27K
kEdua5GcTL+ex2xNZGGA2wlul2V88MxkMDwmBRzh8QqEbqz9lcyxAC6WGkWqcFbCG9kKFnHRuCGk
RDMcgFiGVE2//Xgs3K/WF0PNHlG4qWnBm00T6QKc9G67VklRui+4GyArZHYQBimT39SL/FMME9II
ljqMbHIIM6Hb9qA6Oy2KQ2eQgXWjdo+Z++TNiiJxnIba+SididGbEzZE3JJY6njXKLMq5ma4Ot70
fGGvn/vSR04S4puicNSMkM4Ec0vtbLoA18KOREZlbs4IAByB1jqE2s1AE30Ac0/H8MOzhDfNvU+C
8luODA0wHhcGdroxMehdmZBf2eRzij9DJMQ1M27iryZXCRMgZdKCTj5wx5sXFBMbo6vqattNgem/
DVTnGLP0pqD0jMrpzUNrokjvUmZ1rYppYp6SOvFNQV2IN1o0vapQ1O3xPwrrY5Rm3V0zNslpcpp0
vhtcHmqdVAzqcqmku/WK3kKyA76K8Dq0FKJxhYwM55v53ikUHPewCo+uFv1DEwLb8vqn5oPIgOaW
MXPwpcrV6KGPYAoUl2WxmQtlvMvZaN/ThnmVUljsMCavfQdiuhd8m1k6MbvlswvyIBImH01+8AaL
IXgJOBJYZfRQzfjxwuPt5QvGV5LZgoYlF00NYZvjnF4Ga8h+p7juvEWWcsiadMUEjmcUo7vv5nqU
64hF7Dw0lV2WSxGPUiymaSBiIOtq9ySSuPjC2Mt8S8cou9EyKnmy1ZhOT7YBxu9ZkpyxtprK/ZQn
VbjgJTCnU9TgU6mXqeqDdh8MuNQe0jIyvFNkmGTMeS0WBfil23pfDI3JV7nO4+RU8Sayh2ndxWnN
ED0vSWmbUHEmYAvaOwOKXtMU0ImJI9IOCvtgkWL/zPKLZY7kCMOLYYmBX0PGllEzF69U0r5OtLAv
0u1ryBUjUYpRqOngpRTlqcJW8j3Lp2o/+GkFvTpgX6CHWWTSih/HVhsHrUhBqgqb/Uf0xRHnszp6
EqI3jhO+69YChxh5km6thiVuEno/EDBLApaRMJlEdDUfzckx3s00h8rRifAcEblxaHQbnIYhng51
ilY2JqH3IbNYk0HrRxkuf1V9DBqTBIGqaZ77qUN4VE/GKZgN4rcH1z56on1qRG2zyOy0X4HwWPAD
G4QmFYcYUoLaZC1LYjTsTH1jOrhTCYKhuZHppfab5Ckd0O0VZcIo3jHgjoBCEjhiRsGb7Eb9bk+V
tyaMmbXTFOoQTaV8N+eGkdiNlm6PejpGQ3+Dega9F5oDZPClOgS+kTFhtW4cUdvUK9PXXbGaVA0R
Q/X+ozfPnVhWHt6igz97sO47CIt+x75Bi5F8iiQQcK4LOnVwYwNctOxYodoMn8xiTh7MkR6nGp3g
OCRzBe98gsXTzumzMvpiCbAOS8bHGcMbNMuys9GzJYrNILQZ4jLGGEBW0/DNBjxmvCate99O0j2Y
MPHH7eyQ2+mE91EVB58Sr75Ua0gQUetfWinEtrNUdywzG/6cb4aX2gzTx0gxFJ5JO9CLHvgdZVGR
3WtFLiUq6HOlxLSgkoW7aUUkE1JMLUqrz9Ep+eGOmUN+ZDM2yMaZSGUrhLmZgD0WTRRPx8Ryb2kH
WRUcwyJWu9Hv/Wtj0YKlZuPdjSLzLwZ66Vc64PwQsizZLuFsFXN6FrlVrsvMnQknF+JVzi35o2YG
qtJABliatnUtivl+GgVj32R2oIfmAYG+ISVp283bhCz1Fal1727b/4qjydxKz4k25C8mu8ZioF7V
nbVITfmr7dvkGtSIaxXH6i7JEs1+O9nrpnR4yeLqoPHZvitbaG+hk52neVD7xmcsWKrk3neydlcZ
0CdxYy63jT8Ud6IjOYMbeCMeVZVUZ9aEA7NVOaHe+hG2UedbsMG96CL5mwlV8uEUXfHoZz5Zv+C2
OwzFpzuA4ZIZMqfFyGYX4NPNHCH7zmerfsF4CS6rK0Juvnm+2Uvzi8fmKbAVTsbsNKsWQNcL5nhn
Rox/0wx6RDYP/jLLw+zDmZ2BzDQj6oalakVylkGEuG1sRXsBIY/vnMhzjwWDpA2HtYRfO9drF9NJ
d2nEaIGhNNTh0dHElue3eOgh9wDVi+TcNoqwU/LF4h3+1jfGaiWmY1Z2jL/anvDraZ7VImHFEi0G
M34RVb1z37ZjtOhHFYGt+vlSDqQcGyixZsfi3JHD5D61SQOo6/aG8dlBgj9GRMPc107hQ72ay27D
+QqPyEuLX/EEy1sEZrbUVV09s6yDZT0GaGInSOz5ZIWrrI0j2qEGzvLo2/eNlzTrGS/SRUtI5qlw
qd1cyqFtkQj5247pAVQa4sZS21BbHbqWbYyyEwvznqrQJW+diQX/GnfxZohVcGxIw3vtm2Ggwg6j
TeE5+WnknatHm8Eb7khITYxoE0qIZwbmuITizu64alr4x5WmsSBN13M/JIk4m8FOu+Mk2GPGvrff
A233e+JzOTu8PFtJ20fT15r3aSKmjcfBcsrwaF3Ffj0dbw4KmwDl/9Gaq4cWN4jH0u2SndApusBw
Dt4QnJG5WgWbACvKeRFr2FJzYEarygBRpPTaS+fmJ2ViMVeEkC08IxJP8RzE2xC+85MlqrcuzdwF
oaPRqkOAtEHcw4Yzou4s8jpfNTHuYPRa9aOUid65FWrdvCEscNRJc19VWcBNGqJpVYcuViUjXvs2
ZiNrW4b9oSkhUhJqOr5hYfWBH4w+4lXgHWK07rzkOV6eKqYqnM1tqAuYfgGhPTdndeJPW2fGCsLr
g7t2zKxjrNRj21uQo8sigsWVsojtxH5KmXxecyVI/0Yb88b2+5H7brWVCm9c4VHbGFawqiqEdV5L
iGHnNZ8ssGlHrOi89iZRPE4FquRCc69rwLDN6EXp2QoziDZ9np2wrRCInet6aYzlk/BdmF6OmA5u
i9mRif/CgqpW/GgH1upsjfFmmmHDmBNciaxvSOI1OMZJ1nzrqYcXJFZo4EYMy4+51sauTRDjTzMM
MHIkXVoOvNGWRJ5F96jretjkWRJtgtntDhZeFrAkZwBrjUefv0Avr7GYlp+mP5anoCRhOm+8YU3Y
QvVEl28tJWXGbVkPGa0RTMgxni5OUsqLLPC5R9sqtrMRhsfWbDB7iZzbQIm9FPyrfm6MOPwMQfEu
qqBPpEOlRQ5xOloGk2u845WYbhLt37KS2/ip9KMUZqHunkQz/WpEKAdQw7QHSqgKNN3Ky1auxMtt
UdYmCsK6gJoTyvERdNTfsbkm+znO8mea3f59CibzHEUV6TmiRJRryOyhib3kQCTVuNAYD6zYHbIt
6TzdvT/kBUyh8VXQF7yGhYo/kPKlN62nv+bVhGfMEQP81+jD7DATKIruWljtxapTwQAjGY+hOVaf
qYd+k2MG8yOzFO+qg/GpVVg+yL4YXzAj6V9LnLBoOWqqujjuuiPFwQuJO9Ya2FefsoRtt6aP/sSA
ZJthlQQj0KhOvS965MkeQPo8QiQyabTzIE4Pjk9e/JS5l2xMBHzFNt2MmT0RaYpMoSGa6o0OZTyN
veUV8K6cetuyDx9KnEBPbVxfMSHH/tgFHs1lQybomBTLsI2Po2eIuzaq5b5LS9COomOOrqMOIw4n
WoW5dd9bBMPG/ozDXl6t2xy/tcEGTlB1+8CGPfyea6+llZBlvlXSCfZOqVBzipAhqkC57Y/tWejO
2vq26F8UA+m1Vd4OFS8cV0nUNmsVdNU2yvLiinfzJXGw14xzW+7tiRo5rpvgpnIlwhTxJLyqyDqF
FlB9MdDXG4S8nmvfR5iXMHqhRZvCbBlbtVctWlnV+wBuz3ZiruUX7u2VLXmNLfOzQkG9kwHzamzc
gPmT3tslNSLLGf9gCHOIiDpks3vO8+5YjM10mUnEu0RBWh8rPCwhYDo1hUbsHvjx+SFjULRwnbKi
8LSvbtk465DQcmWl/qIpzO4akqoH600ZALpN9miaY7cKUvjvLplfH0NKXmdealyp88hAjWw3Pvwn
T+2qQMqHRpMUUfvldz1b8TFitra23BKlP+3u79R3nFVkFbjC3BxUDzpD7XnjmOS3mFS5BrQMNzfX
saOYm4FqsxNvdjCXn3quIG4GII0rcJuGWCevOtd1CeWYNqjHwCy9UUWVwBdFphqOiel9YX7rQr0z
3HXu5h7lTduvPDUQIFxNdX8wKaKXbVwkK3PyQkY7SOm12XSvWVKXS4c65NzElbXVVl5vTd+NXjiS
I7jBXvqZOBF6pHmADIFYjlq+ICQqQIXdY+WzMlTQMl13AObNDrY+FTANo5vru1iZ/VEMnrkFzbIg
9c/GbQB4gnTcoxJEnh7W84BGV+XkTUk9/3a91ESqiScI5gSjWFWdfAdLkZtmTvq1tkDsIMWH2VmN
ymJiFHdoQRr0teh4P+u4tO6CIVSbamR8jnrLCdYkL/RblVT525RY08ksu3Rn16axxJm8Pbtjrk7T
lPOmjiQw43+Xb0QZEwEeuf0HUfVTuLAKP1jYpCw/jP5svzKeGDa5HRdXoWgTmbnr+qQRny0jrdyH
anKmLQcI+h7kaN+edshEb7PMWTH7T99zjDkeYfd8R74932XjPOztGFgG0oRN+nwmg43SEzzQAGuD
W3t/YvgVrKYw7DdGng1rT5J5AJ4zVBj3RXmwThzDuICZgoPZ3nBxk0k9xT2YD6izuzVbMd+3cc58
JsnMeVV6zoxaWJqXoZ7bo2GbwWPczeNdmJKPon0UwEOFHqoMe4zCDJnC0845DcNkYChD374Zyz6E
C1DcJFqJ91G3Y7tqEr9GTTLjYsBgmJPPdiD+4dWR0p/2EXQCC4uIoB2eLXVzdpGOY+B6EpB4W3dx
dMFCfFobbTyjughvMCf+F+SlNY4RfBcG+98N2wWbANDx9mbUiXg1RKCuE85P8EZMx1z1LlJ0b+To
AoYfq11DzsG44vXV6yAx9dbGp3g121m7l0ksaY7iem1nncIVyO+bLy/zbvXz2FmfBqOeq4cHFXRI
Zx6e44Z2FhoIUeAYQR4rC+2a6ZYF2r56pIquPMCfaHRNKoUM5q6sps9Bavu+G6g37UlQURrB+BR0
pl5nUIJ+F4jLv01lCS7Dtz4QdRq3t6a/CK8M73peYovGvba2AdHKLzCR4JHGwnnAKqCH/j3KvecZ
wOOdADCGCmEsUyy1tkkXY4XXePUiL5pLoAsSP1md9KkuVBQSBBdeZH/gCgFFQFF09ERmvDb9yCCv
6Qocosdg2VbzXYr0dZk5SgMzOt9pkgw7StvfgerujKQpl6BGv/CCvFc8cL2Y/do6z04pUK9ZFUPU
gQjAJDXhG83pCtTZPqTeXG881uOCugBlz0SkU8TNUF3wIkY29JHDlZqlvAhVHEp1Oyi0cbFLOLMU
r9feQygxjV9SGu9N4VA5zbP7niXVt4xTout0YFGBJNgaCTt7mKwSDjOz6ifKiApOngMmMTntk9Eg
R1+ERcBcPUqR8BiJ3BhFS8vrpfRVXlb+tNrSr3MC6c5l0/QcYPG4A9TBsgqNZqEUbX/u1FDUXetz
IuZ4Q2Pubtm2n0YBHuHAWloBpp3mtqIONBvT2I9NelG9l9L5tAEr2Xyrczm+3BKkVrXpeTfAPF56
NUhHbczqXA9xeSddNzp52LqvK0s8gqE/VxCTN6VhPLuT695HAYm4Q0m4OojiKsRz82wkwbHwMLsC
tglYafSiY0cwrN/oX61gQ+z8clz7cKAo4vL/xd6Z7caNZGn4XeaeBTK432YyV0mp3ZJ8Q8iyxX0n
g8vTz0dXT7cz5VbCDczFAIMe1HQ1qhxJMpYT//kXrkF+F+3KgBupGBV1QQaPXOHKn905ceJ81bSB
woqMl1VeFM1uSIbmqy4FQl5fCK7aJnwIvclhe9TWxTQmzU6tq35tcNnb+lOhAKGMYk3LxL2xAg3N
jZ35Cy1M7OvcdHuPCqu5U80OmVYZ93eFwaLsJ0fDKjtov/gxSgWuQulTn8ybrJH0JDBpPeiamWk6
AoQAN5FIYRFXQmDzOGbxYij9nmzOZpwWXSAD2tPGV0ebnS1H+Pp9mwI2aLnyrQESuLVspfb6jAnc
ucBohVo2N4GRTZsmGPFz8c0ey3xX2XSqbiHr1CNQtNHS18pU/dzPw21QufFN74TdKmvLGmOm0cQX
ISw2JYDdvoUWtsXZoV/QQDN3mQYY7BfJZW81wYYAiQqGwpRBis78yzrtp32Hp8g+57F+TI6NeGyE
dpb6EDrpNGHAqQUu3D8lvhuKkH0t7qw1aX/+IzJlkNq4QpcyhkgztKnuH2yUjCh6FNO9aFK95S4h
WQly1JABlRr7sW+YVzI14f40PhyhRUZ4PDJfTV1SIVuwyuLSorZTMIuhWXNFEwzQJcudQ5qYIliV
EXrfoGhe7FYvbjlIAn05OBA3HU4VPGRAkVQJec5qOvtG1R02BzTz2CcFbuzleXmV18imfbU7QLi5
9/GjuzEbX7sAkPBtkLM22yawYg7gugRRYXP90JYj8SOpPbGJKVGy0p1KruwOdH2h59FDJNv7zk+z
6yJy2wMPQn3UaD61dgrbIAlM0M1sTAtO/bHY4BVtLNw2La6ItDC3iGO4wdOnunJklt+4rWO8ilAB
8QTyGO5iI5oWsnVml69ebpXOty/pumRUgJ0OMuuG35Sxe82TKmkXAm/xLwBTcbB0dSu8Jn5eeqZo
5L4sOQoXbmnSkyvGfJtM+Odxb3K9SRW6VwtIJyng7yIlF+i2homWLAIqoa1Tidui1Po36EH9YZSu
AnqGq5rgMrJQzaoCdm++TaHd43uFQg/jb2yD3PQW37abtDSLK0Fe+25KbORB0GtxO9KnEbrSFPYo
pBgI8KbGvzkiSbuf0A3nmUDXMul+Wd7SVM7u4G1S/7uJoT9wsbeMyzwrrKeR5IwaG38IWbj+cGzi
JhUNUNcgQrXtW9bOqSGK6OnBkEhjY5pnu635nFddTk8We5FqG0dpyQXLqLVmRUSOeNOyxKVJ2wpf
3hhSoy4MfXFXk3dce11m98F6KLS+XA+mRCbqRmarLmhl9DHC+A4wqRf6XdPCzFk3Sls8FjUnPEhl
UXkDTMAbOnH5uhisYK/QBgt2UZVHLdqQxhq9MQydr51BegAqOIzDx7zrmTAWxfT8oZ+6NkALifPL
HnSsu2XLBF/Am9yCvikq5CVVeq+MTfhmm+4tBm32t5Hm0EqEPbyj3LmpmUi4cEE08xp6HXdRZmFG
BPlnvNSKqaQXjqnJgyJE3qwnn2ZHmdZGd2mmfvGDMNv+VpUmq15yY+t3im+bt3USGM9R2OvqrovL
+DbmAovAZehRhVqpA+dlcgt5MHoZTnsVgMl9SAyH4CsRsje84r+CWqfv/GbOCs6nbkkOgHvD/sv1
NR10XiJUZpAdqzWS8tCEhPB4VZx193Y1waGMbUOVj4Tj1coubY0gJDXF6LikKcwes8hGrihN8S5k
YMRby+C9TrqQ1xLS6CbxKc22mmzyF9wBh7WVJCifstZEVlZgYAcxoIsKWu6RBDlV5EOEP/qaFyYu
WgUrriTswfxS8d3o2dDnLdGs3X7Nva/aOkplHkyuCruh7btvlLzJctLrucvc4BHUJy0MrBBtj5nU
64bu3qaYenWbV8Z0VUSxsayFQYij1Md3l4PgnlzTGptGLiyPjmkbtxgtYh6As/EDzm3Ok1pBeHWV
yLYWfUIn18+N8LITVrYv6Ve/FWbZrkcMo9m5Or3fjBWtWlrvZragwVZdIoiAmxVUIL+QW4GAbHiP
32VTZVtJHudD0jdPhuzYTPVqbxYVHLkma6qHdijLmfg4vIN6wjVt5vKqF+KlKIbXoGyKi8jSNDSF
Zossz5E3ox+C80QB1S47tLpMQopNEcMrE3Vv7VVfOhvc4DLQFKrejFm0dGpZ3I7jILahYhVXVTAw
hZVh1BAxtLlnadAWBJXBVcSq3JHj/ZQOofhaWUL7FlvMnwRO9AO+sdbBrRFblS69FKQXlieN0cfU
M04e7EROO3oz95TdAuU2AXgbOAl84mhyrgzFpYvVydG50CPd2TL77XusYtRHCxUlUSqd9YTRE8ds
lOuF10FeRPMk4TBEVeEs2aLUA6wZqNH0aJ8cuNQPQR0OV6oYpAftobjSLf2RHUk8tCRS7LuM/izK
K+6sIsGZayxIG50Zg4KmDIbZ4QxP43JdYATS7dXetu+VtDOxhZ3u/Er9PowB/l9tBOhAiFu9z9Wp
44pmurQXI21lQo3zJiCKJWs3hxUCEIcp5UxTVy8aYFFCOWxn26hWuEtSE2proVfWemLzWg5sul+I
RSJqxC7epkCwZbA5BgtHWuKO6JNiaRlANaOt2+tgkGjoKW3mRZekh6qADGBZYblTA53lFegU+0Gv
W/RfwvCq1iqxAlj6VuuBRRkaF9oydephGbSS5u6IkL3IyLRneYktrWpI1HMRD+Wvuu7E5NyNju+u
wrK5DQwLur7edV/CNI3e22LQHBSUsv7uykFctWVVfBuqSb/v2QLQnrnaHGUu3+EpDO+VW9jbTMFI
nRbfnaF31UWp+sOlIlhmsHDvICjexHZnPkauv+JUUCn/9HSX+C7aPIR4jqiQx/EbiIJX6vKaVlTl
KSb8E13B1tzH7+wujsf6ZkiHtzEJX6WtA7qlws23U5o8WIZV4I/SVDfglrJfE+MQPfiNdhk4E01f
o7T8Cxd7WIR8Bp6CMwoLc5MWK2lC9bYWuYOOzW7oBg/0Aoahh/hg6FQgehFeJEH87IRhqMEMjdsv
SZGCPBuJ+cDUQDtXGYm7cCxrmwTsGJWs+Elysi87+GOAfphhOvmEWjtDgKiqOCkvZKbPhEQ3gTnK
rfyK8D/9psrijdM2tTfqav/KrFe8iQrtPi4klq8ujJOw5991QmJPzYLyQ+ta43WgZ7C19Ib6Sg4a
/oq0zO8DJQnvaRX1DyYY/S5qfNThraRCqH5aghkFsj/0cuKpoJWwjVP3WW18a2/7rnGB9sxYwD4O
f4B+gMeGmZJoSw6hnOZK0Zvh98LI0PETJw5tmmQdf9MmUOw11uzlxMu4JqRwai5h4VhrXKHGZN3A
zsSOE8GRQp/VY5bRriJpEtc06b+0baHwcG2oX9ed1QLnoQ6jWtRDLMRoHm/dSdg7rQom4sUMa6tY
U7ws9bi9tIg5iL5kWNLu1SnADMKpzU1SBs2qcQXmJm1bX+ERZ/qbmnbLiPuemmv7xE7CWQZU9gG6
qcTAD4iGaWx4UqjKsJ8qmBtrOiRoli17ukxFjCxXU4ZartvJ0qOXWAXNxtpGGTCca/NIa9/JkMef
xtdgNy0QalTxrSUD0WJqU5kPdgErzzNC7DL5Slxq1C9G7/jOrWaPgX6Jb3DITZ3mroxWbqYmPKho
3RF3omAw4X5jXOpcdQmsowsjm5OTdYXktVWdhFn7rR2FoVzDJUuDW1q5fb9qK8No30bDlQk0sEhR
sudJqfy4xiOO3GpkyODyar6QdY6a6dUtVS15D5Uet0iavvRh02TamlSw+86spmwxlsAahqwyz1Ka
6QDjelqqDjLhCHD5HjwG82MNauEFIpjxoLLmt6HT1OFu9DO3wrIS9szglsFKqzJ77XdItGWkul6n
Gv59i1I1t3owRXg4ppZcxrTK38GS6q+2NeqvJvHWNuCZwD07j8fhBwjF+H0qe23f4g32KjW9tffE
OZTpTTFy2VrnioyN/VBUzLmxMcX3MgqVZVmgokdZ49Cy8WdraD9R1A3ikPHdCrkuDYbhs12PGWqc
xoh6ZwWJJqVIFhVkxU4HM1koThH9KCbaT7ukzaGnJJxv77oqJiID/HLrGi3/LGFnfrrBNHw+2F1i
TmJPYC4/bBybO9/asi1/XDijCIpgwV3WD7dmmtfy2kiVJvfSRkaaWA9gvSiSZRqkJtafzWT4sBPM
MvkOEzQEYqMLao3yCVkTYhJgWric9TX1YkyVaKYCz5V2IMliZVSjknxr26zpttwlIzNeO07b3Rlo
8/QYsqFqog+DNRLQAAg7H47cColbsRmDIX2ya9E4Xlt2qJZs2+8PANw9Kcx2npVYTeh1u7T84Ctt
BfmSF5Mde+RiwTPQyV/WRk+zfdrOq2I0suCJrTJNnpqGqxi28w0ZzcNYZ17LJbLY9tLFC5dLvt1C
2kiLgBNU0fWgXUmn4OXEfVonDzCK9FkMRvipcvNfMy/5f4GefV3+yO/b+seP9uq1/L+gJ7ZgSH9C
0X5Nv0fyR3NE0Z7/lb8p2jY2e6YNy1qliaODxf5TNWyLv7DJI7dCzCG+gLP/omjbf8Fa1Un4wEsP
6I4p/U+OtqL+hcLXVPk3TYN/kWn8R7rhY48ppDrYQjMKHpCuTZKMceIdR6jbGFlNq3rUHa51V1Cd
LeGipQstRf1u13V0oblnAqzgq//iosWYjkYCsAP4TbQ8D3iSnOe7Q5jD/aRHXuXkoKa0EEb8Sle/
fIbfKKJ/5mD9y6zrH8MYpqlqNnW39dNj8BdBtOaXmZ71IVbnkC/Qba90f9uwU+FENy6M6KVInpJ0
W0KUTPfVtCIqDf0FMjYgQZTI1SMeSYq9t9JDqXjIWNp22WIGgt6McsugebOc8MkGWOo8bgzUswTq
pNoKxoBzqR0wUbOLVS8vZhJvvbC0hR4i71nGr8l3/RU3QHNa/hSJeQ2EdVzO3sa3qoex7YHNGqHE
M8KLpgvbvcwhgitE1fZUYV6ZYH0LhOL5Z4LcPswDvomwacc5GD8apmDG/UrV72vOdk0yDypBZ0pN
Jkyx3eAijuVdYqYxcrdgWJL7cPv5R/rdVCCV2YWnaFuWcZpCmualORZkCHgqnH9cWqFE5W5zLu/8
JEzq76lArAsPhjnlLEU4fjrZiHGoDHp2ob2TtVfZnpFvwuaqd4tFId/waSkFwp/6Ncu/NOlBM6+z
IsONZO0w/XFHRum9qI2dBgN26Qw3tfuUYDmRq9e22Gs2RfB1hF97P/m7oX8Z9UcLKY4tX4LuMCTf
ZH5m/fz2cUgQtAg90sS8io4fh6gie8jsWPUwTNasa7gf+DfG65Ac8JFspwhbsHg2HUuXGLx4Q+Gi
DbuJTf6WmQxl0dl05XWmrsPqIp1eTVR44U5Whpfaw7JuuGGix21WZb9LqlXYeXZ8cA3P1M0FnFJa
S7dWB1WNU6zbfT4bTvQiPzcGomBU9kImoeacbAzINnwI29bkpegX0NlNa+D9gauhH0MXl0gqK+PM
vNdObBN+jjlHGbkmm7QwZoOGXye+bk4ZrX1zAozD9S16TaPEP4SmAXe55AytYFxFSbctXLbDrtTD
DZJd7/PHntfWyUZl2LhH4N5ApDcJ4sc/oQBvtOvcGjA5RhKM8abeEGkw5G898v2/ZVT/3ifiN2Oh
lCYc05qXu3vyuIZid0R0s4FguAztvlug4LShXxWQpnpVrj9/svlPO30ylyY8B5UmuMrPy/+XLXgs
9WISSBU90WIfH1cwseGJLTJhYn6X1l8S217GSUOn0jlj1fibjYXz0zbIwDQ5ZM2Tc20YhiqpWpNH
jEMc4ow2xkDBCs6cMb8ZhYPdnYPlNQT1pxMWVpzIDZ7RCxHPLrq8Atw39LPZi8fGrj+3L1Ml5Zez
DE2X+vOk++U1JpFe5HpHFxvlAFE0CYA5JDe90zAkA6Angvw6VxK4kQPdZ6Xtz2zSvzkbTGRaBo4V
HNbsN8dfcXJ7UE74RURfTHNT+bVqIcqoo4Rg3ozjPsAynRl8ZtTfbAamRnWgYSrMqKeVCYgZZLU0
wP87H5JNKDTwbBcaOx6iNMWBbDEM/3y2/nZEdlVbFbT/1dNsNeLWE0JTaC0SGWksDLpu3O987Kam
TCMXkMbbFCME/3zQ3yx+5HY4t8xaOf4z/6hfvm3pZ4hy5DB6mXZt1jg1Bha2tdIt3kdHPzNdfzsW
fN553bMYZ8/nX8fyjT5UkoSxaHCs+zFSkEpjemvFeGOOinZmCf5uNEbC3YAal91m3nl/eTIfU/0g
ZYJ4SfcoR9HTkSaVT5DsCNHQOPMaf7cSeYdUehb/x0Z6PJiuBgO9P+5MIoL2KlA1YQEKn+VPP5ZQ
Sd0mJh6IH5bSyU7dBVMfqC6jYP5kcE/8KiWWB+TrGkKPzpxMH/ZOnLlNw3AxsjAsg9Pp+InIJvZL
VqXqxWr0WNexv+m6AIvDRP0yNi7iHJl4jdaTOWDKM19Om+uho32bsS1QRGHblEvsbMdjhyPSSVoO
c4ERvU11/tjEaDYHSJR4O0BzUckggqDeQc0kAyEM16qPh0tJ/s7n7/vDiuR3uKqJ6YGN/QEV4vHv
8AdIxk2Ph04/td8Fq2NVqsZm9JNNIiDYRQq9m89H/O2jU45SCFjchkzj5BPHlTNlg+xUT09A2Wam
Tl+5tzG+PkRumVfh0O8RcSPmr0AtO9d4J1ocyGhMzv2QeaCTbwCR3OTyR76lZbgnxRDeIghubejs
QCcEW2TtLI/DaiiuoG065vUMMCxSR3cIP8Aqd+jxQlCdvemGB8WQ4Zma88MZwH2TOyIdU1012I5P
zgDMwmkoavEEI6sMaKGE82a8rPLRq/raQqkS7rMyfP/8YxgfVrULTOwKg09vYAY/X6t/3ULwM8JS
JnKIkdAKlLPvkvtBEDwX5Q+WDK57JvJ/XA3JE1s11tqdvmQWyWMHtfmayi9dtxPK1xA7YdSMSGJu
o9nKuMc/CAZ+srTzDUT3xPwBJx6vR8PZ2em9HyIzWZViVwRf4vFF4n/i3PbJ1dBcf/5o2s/t7/j7
UujOdR8Cbmpn82SiEe2lxUhxOG3qraHuFS6ftvl9dG4ymr1181LlcH+ta3/E6uPCd7i0PuDJSQs4
C7nBmIe6/6JBUw6qWwMiQ9Q+W92mtZ+dcptzqy02aHiJJcTmAxIGfnREP6VLtIGlssQ5wSIebFWT
P9GszX7tx7tUv4zEbd7dKsF3kV4RrqWXr0V+hVvyy5BsdVAty+usW13D3c/Tn4eXVKy79kmG92l6
gBdjdpf46FnkEn0zw+cheiYdy1Lo0d1Pxk7HppV8r1k6x8a1Gu9mdveEJw98YiI/zJu2vsDMQKse
Cxdwnnn10L/FCE6iu9xfRcEmSTEq8sQjmWg5WWvTgWocYREtomZauaUHbZRbtqlfwA7H6Yboshy6
ndY/khdUdUvHvrTlhupFcXZzJQrboLIv4BOSBC9f0PkNyDOgSLXYX3l45F+a/tLqrlVyuBLcEBcl
cjZljygqRuys3YR+so7a3SS/ZeG3IV+N9gJuB65CRr22ySIrcJLEIAs5wCtpMBWGa1j+cBdb+cMF
cQEkyvrGbph51H+8XzKnyEZ3QJZUlRvv8XpxOJyy3KZmCgudRpyGA2UdxKtAyZ5knIqlw7Z+5kj8
3RK1KH9NsmV1w9FOLhSQn4u6HuYSn/+yzCTNDwdrmnO74U9Q6HS5UJip2AhwMGnqyVYwEyyAYu3R
6+U1XCzElZa41f3Z03F6a2DgqF/L+mHs7gbju278aJC/karioHUT6i5sPJQXOLZY6Pek1zkr1Hxt
tDLdTT/TwMOlhlWZ8xwjnib3Ucrn8HZum90pFxkxnjQ4VuEtdxZDLDqqQOxtg719lUGkt9bhRXtF
8i2q1oI/vFri2HNVH6p7gadyurSwII2IA14UtyAKBQ5d2iY4yPSyJKlIX7vZYofBMGZm6ZtsH5zo
niROrMCndaCuaOFh5Yocl0UP/r4YK3rUUbpUzadyekOmZfoXDW4z0nPGQ4Sop0HS81zXhzLcCg2a
tTfIewABx160tMCGTTd5+C3peDTnLJEFqUiGs2+aF9q47a0/PRXpY2YMC4NVJrWvDmLqNuv3rQYN
iBwBS3mFhG6U13oDGgY1sa5uZLYvuq1N53P8/vkG+aF65MoIjg3EwRY5///jqdxicmVXiLe83oor
z4zkm1lj/KyYxsXk00z+89E0jTMGrwyHK8fJ7CIbzZANJCIv79HxG4B4fYWZmQ05y8uRDX8+2s/c
9JPJzJ5vYSdJ0qMKp/f44eqkmcH5cUSz59B1z2DGBzpUYoilCHaYeVZiD0inkiU92HsoBOaZ42d+
e6c/YC6XSZEhRQo+xPEPiO3Z8SjheYfJ5ThPI+hpwm3OrNrffEOBm4Ugih6wGluR41FE6krdgFeI
15i5TqfaniVJyCA0nwaMM4kzr/VjjTKPBYyDVtQEcjipmOKqIMtLYtNfFxYUK2XvqgBc3ENwq849
P4c4bTtheWbPPX1IR6M+4S4ACgCOyX87fkin9KfKRBvn6Xn/UhY9+lHnSkzfqiZSzjzg6ZWAoRhG
UBHrFMSodY6HiuWQB9C1AZw1t7vi5CsTGB5W5T7OvV7h72VUe7YejevP5+tpGT7j9Q6PBmpPN45f
cTyupsBfgmSK857PJliRDL/AzsKijYVY3O6xglPsM0N+WCKOxkFGmjuArW1xKT+ZoXqo4gwhbSBv
s6STquDvJCPP7olk65RkNdHPT2IhuBRVhN4Q6Pj5I3/8qjjkMDCIC4UnV7DjR45SBfp54haeiwTG
jkc4+AUVTT2CArSTe/fno7lIhpBA0oexTs9toZsWxG9c2ZUi6FYqjFGnotcd452zorc7nTmzP3xP
/kDWiK3zKQW9pJOHQzfaTpSXOOI7A8mZuKMubMioXoUUYVmX3XuC/9aZufsTr/l1y3GETkECEkBp
jveQeTKJEJkpWtH5mVc4N1O0dhPYHP6lUz/alX7d1TiqltRxkIhq+EEYY5VQdrJL/oZe5URKYrKe
FOy4MaD/GspHOu1Q2LHxC5DKXnYFkb+XYxGvevexivANxMeef9YtbzrtkT8DZQd/gImynoo3TeZ/
VcmyheZfTsXjH35LntN2QAcow2Y8+eQ5MaAzzNFJcm8s63u/r5VlVRrIzwbsDE2LsNXPh/uwJwCs
MGnm3obrAhecwASY4Y3WEGYRPAEuZ9C4ONZdmJmlWKVp+j7pczKlGt3I3Lj5D0bWGJ6SU58xrOMl
Mmnw7NqiirwxTkh01Ehl7E084WWobAgQW7sNkaJwLif3zMAf1ub8yKB0wNgc2YY42Ro6ESWNXsUR
rUN1M6oBurXI5go0tu6yzM5hvB86BA7vlveqGTMgAhB6slpSkxAvs50GNLYN3aPGq2vISlkz7Mze
Gg9FM+AxKfMD3avAs1K8f1HInVk9P/Hq49UDDEyTEgiY30KH5Phl66VtDlk9DJ4OeSHDTUnFPFY+
apIaUZAkZURkrz8SG6UFD1KhpUnbMyJRtNnk6Y4JPxXY/6sJJNLVmMCOwsdKoPRDfQJ7jAWS34e0
i5x2rVo3brXjus3tEI0sSbRwP2ChEGdevdIRwR+XxcRfWYQahhE1sAOmUVP6pY/WLWot6pCFXjLY
pc8fjcMWrh9n5vzvPglG12DhtHXBJNyTtyFjzQkylGpgw6TvDlABzay9SLkeIN3RCBDF/7kryD8N
zNuibVDnmGF45pOcVhvzfQekkc4+1t4WBmTHX0T1zQjREAW6JvHannCeGhxCFeQXe7ADtKiEYgTK
+vMl93Hmcwibjil+NmvZR4/HTB2YUW1ddd7UTl7XEWCBZAeHAgOwwjib8vizYDqadDoAFAguvAWG
5YA6Hg6HXmSKSt966q3+Vtyxt6hfsCmxxlUS3CJY8McVf6u85eg56DHWXtFdSqAYHIuTpUggAi3U
x+ki2BH3qmVehtWO+Z2/dsNT517Dm4mrjaNh8d+yYSPc019nRTRTSFkKExPgHYbEyAHTepWLu2J8
GYiSCEnxdMGtmXjLTF1yXeGvMEKRE6GwjUnqrpZN5mFZDHeqMsEEVqZY2uRP557dbWfRHsFu+laJ
Ns2cCL1GxV6ZGz9e6jgSUQv7yCYW+Y1+Pd20KCPjRfpgP5EfAy0gJONG2Wr5lqQc19gYwffcQRe4
ARCeDi4XLbmkKQHUJO4tAnGtLQrT1D2U5rqu13W8xFU8Vndls261Ta6imz8QmdDCgHRR32z4H/FQ
wOlgEpux3WFbN+c19Ov4axNf68GeKJVoQWpKeCkOw3P/nl1YX8VGucx/4IkmE3MVmNeYwPTjZaG3
UIfXCSkR4xseFGXyFmW3GdpPwnJuYJIF2h4CGaFYlrp0v4dX05kd+sOhNE+c2drPValYaY0dTxwl
1aAs+RMTpyFQOdY7B6wDzVWVQv6OMLmZ8MtbRrYIPIygrN3nq+Rj7fhzeEgfc+cBhsvJRSAyiwFV
qdZ6ppqvCoxikeR7/Sg3CgpUvpZJg0Wi1IOJS9deZtmfXgkY36I/DxJjGw4I+vHja42LXrMOmGpK
g/Vm2EIc7e5RN4NV5MOZwT7sQ5TkwC8mZ5M6b0cne4IThXZrN0jqYqMOts3oXwGbr0t0egt9TF+D
lskQj3i9fv6SxXx5O9kcGBcGj8O56IDPHz9khjV5DX++9bIYgqgmxUyqgHiKCaKxYdfOLiJTn4kJ
2pKm/nDdphYxSLDzljQuJy+jTFsVaXhB8FxDqLv4AR3WIed6IYhBM2W4biMF1C9q/WU7p5R8/vM/
vjVKCCbnXNwbBCbMM/iX5hTSIyEVl5xCqVQXtdmhu4KQ2VMzdk0664yLpz4+c+mev8TxG2NMgYPW
zG8wXefk1EJm6TSYwlWUaRX5KuawsaxuLytxQXdFYVvNznGgPpwX+s9cCt0VGEdzQT15SunDezYk
PCU6LO0+Vb6lGFg5uE8f+rF6+NM3Ojdo4HbN01Bz1ZN5GBWFbOyoxhyes2hTqWBk2IawzxASZnde
TiDEnrI4P3MkfnypzD1V4wTGNR0A8uRO7Eaz1jAv0HLODv8Neio4MOom9cWIbh7PtbjLzkz9j+WH
zoSZkUj60/QDnXlp/DJ5crPRMJIhFVobJGlCLdhfT/drYU1EFmBTTVCBlfbYtWVEcnaiwh2oD5dS
S/54m8WmdaZOcU11DXF6j+vKBJeCSs88NRGYJ6EXzdwU50ISFvyK6L2KKTxYoTeY0+3nH/vjxDoe
+eStI5frbOxoGNn27MHxV9KNXDSUpr0K4jOv++NhcjzWybIpQYVttrPMayrl6+hw1Q87HW5isNDb
w9ReGgJ/d1JbwjPjGh+WK+OyrbIV0O2Fhnn8lbMIvW7ZhUBzuKMuu7FBQKjkwZla9ndvkrKeKwYH
BVTFkyUaTGYcKKHIPfS9cxqlhX6hx9QtiBAPhucYAL+Zuq4B9YeJq9s/bXmPHyqG0e1OBdLneEjf
Iit5RzuAiEfzr3pOjsKvVgU1dZja9o5+YECv4tzpLObT93gbnH+CyQao40MM3fD4JwQ1LUQOR8xA
5NcynEFu2Nc00+P8Ekk0Zhq1jC4KTPEWraG9GqOCVBp4HrMvf5HAhr/E3BFHTl0UKy2TP8gRSNbO
HOwQKlCn8Un84wOW34sVDPOMmxdv7fj3droZ6xpUVWLpletSYlkaGOXaqnF9t8Y1QFVPlDBZwH+4
wgyavoBBEGTBwU3rpIRyFB+NVBNjy4+Sdo3L4FelH5auYT/pWeL8J4NhF4GPNBd5IJrjRyx8B0lY
Eybo6euAwzuh0ZBoL12JoRzN1D99MjiLGFBzd8MW+gP9Fy6R2tchXQi8Fb/VVUPAveNuELl6uYZj
4p8PNrPAKEX1GW4/eTK/6VBvIgn1QC63iIw2pm/IBeYUhCdE1vvng304ixDW2JC5Kcc4bo3Tum9U
BohmKF09bCzBnGIi3yrXeZ0lkFpmy10WQtf4fEjt3JgnZ5GCeZctI8AQx6/ItLGSTVESy5bknfrc
NQTCTQO9ZZL5Es0allpYb4m0cPcJlfsyx/Jh4m5mDYpxYfsOrhO6vf/8B34otHgndPCBaejiWOop
eWwYkY2DRmLVUDoKOa96ei3ab1Xh4wXbjZ6bhDdO2pe7/2BUQHkNCgfjn2JTVmHjAOc4RLK2xLal
CYEDkMgolSscNrAxGesvmnL/+Zg/WTH/2tgcsCHdwtpo5vvP8/qU8KSmePYRvYJJpeUT35letLj3
bKtY2ivW+SNyNW07Khhrda72vUm659GYLsIQoyWln8rZD+cVK17/zKs4Pj7//lWIsSkPAOqY4Scb
CTa9dU9URwweaV3pbnZoK2INuiaIdyW3W1d/CaPgMsJK7syX1+a1dfQ+BLg5MPrsJ4968xRDD/PA
6OgBsRyidhsjPif0ftzWVZqu8c4WGxWScmNC8PW1IFqNQ7iK8GosdrlZ14QjTF/OfJ/jg4c3QYXo
gpzMBzpURvPkqB1ipbdVbJ89nEssT69IhHQ8JbDrlduAswdFsZla9xkmjLrIsJ08s1SPV+o/hgcu
MhBbUB+fEhojvyNdMWZ4STSOh7r4QcExc1LUGxRziJtJuToz4vHa+58RuZ+RQGfoH65o5YCNHs2E
GKGFCJZl7g7XRHdOhYObXTjq20piZYKg/u899/+1QP+l2bzif68FOvzAo+xICDT/838LgRznLyYe
rQFdQ9bzN5j2j6wG9S/V0mkzifkvzq/xgbr6F9s3pAfqTzqo3Df+KQQS1l/cdnTVoUUmdFRC4o/C
GqiZj1br32nzaIrMk/0hVrIxaHtISDYuHLdNVnXXYYgzfO1q08p0MNlSBRkVkGNkpkG5ow2xEXWj
bOLA7hAMKXAaVAJH/Trzt1E4osHURfeeZZHlJeaYfOv1Tm6dxNbSRYCe5EcaRuZKJTFhWfSd8Oyg
6NeZ7bIfWEZ4j9CyOYRodhcGtSFOqppewLzrhysn85HCpPm0CiZN/ZH0hQvmMdb1Ak9Ge4t9eHLr
qlm0L2SvPkyUkri8R75zl2SOtrPc1nmWJGnsuGyn37h9xy/swQP+5UpVYfKrW1jlZM6FAm1GXQRq
Qhe38sl0bxApObWS7/uBqhhyRLTDjMC+87NgPOAnVz1VuI9OaHfY4ZeGoZE5q7UGGc5VVfzAcn24
rTCewPygC5UX9H8sdln75aGKxurKUiVWblEGB8qxyVdQg4smSrRDm5nDtvL78U7GZfoMZT54jJIK
gpWIiZutXHWM8RrXp6+yaNuLLMOnc5GmWfTs/zdlZ9bjOHKt279inHcaHIITcH0eRM1SSsp5eCGy
sjI5T8EhSP76s1S+aHfX7e66B7ABu13OUopkMGLvb68Fh3ukieh4xKZEdwQvUr+NtmKbClTvy+ob
7UTEof+ezZ1+TFt/RNmDmwHAQXyVE2WDsWvS2XsenczAJz5bWPXqKFmYfRxhcHOxOyybWMjnUERe
S6nWMz7qZio+KrMoMZO19ffMri0shxrH4xk5AwEXfSKtCkeotYRcyaG9N0qv2FjdQx2ReKkqmOlN
Vj2PubF1JvbwjsArySxGw5hVn96B7Lqthb8z7Aeg/w5WK4WFbVLFxs1I12gRw9l0+JooFtvY6E7W
lZI3z9oyYqd2VyWTsQ1TZdFg/QLCZmwSMF8BKM6GMcl+VabzN2dqt2BTN5qR0US3qRoOnPBNjiFD
L+7aEgJEU+TzlsHXVexHK5X47ypN9SD1LiBp7K+0ZGLMNUZQckQG9O/KJDxaesZXXQ/qicmrdtV4
gqclp+0i+DckwXdrVMnWz+Nn5Rfq3FoyO0jPQ1LxzTHpXwo5BJ3mb1zlMoOLClA332zUfWbGhFYY
azsm6jeu5pfMkI5II4o7QyBQZBrgMRt83JAPPRvtqohv6t5zaARxhILc3pY/qD7DraHDERaFuigr
zGj59JuIyVIzLj8AxJAg84pVYYTPTjnuOAZRe05mJyjBGC46T99JvTmLRkv2oJpIztmvXhJ9d42U
dq502GXbn4mLqT0BeFAouruG20HgnwhhiRFHrgvtZaly6JJddCxmEIptZvBLq4sbA1VgwooKnr0w
JP0VFAB3oH5ui9CVj42vUQrvkmwj+3TTGlZ4sq/+DzAShQNXp8MbMrrAtvI+X0CJsRed66VbWELU
aIQol11SPOuE1FqraNZVzwQ7LT6xQ+9wbzblV58/Kg/ROWcGvCoWLESL59PM2c+DmxArnb7nfszI
f2mTtfONDmMLT92DO5jeRc06N8j46cxTsvfc8BHjTHnpR41f3RthdrskdjUGd1ljQROt44JxxKS3
7stGw/hHftHtavhho347ycj9KjvOvfEUrsAqXmkvmXVyxfzuhrWe0m4oPI7IdVfgvfCBEqUxW5sQ
svmtI2X/PiIfCIyxZLZZ2NFGw59xQkwHGC6qwSDW1EiXA2SsPRhvlM3aPBuP1aDjPWeJPfgx19dW
9cekZutdqxRh8NgvP61Cty6RbAUcIdBnoU+rLYc6v6yUerI7rd1UTmhvbc14yitmSX2jZpQi1RDW
271aOL6S+zmrDQbMmTMP8N84X95oHWREqxBCFkNQnl6t2r57A8ax7KayXgoYpwcDp86+rHV3lY8C
5lfXnjwrqnFqDOKhplpza4rxUJZuDShzeO9TSm6l5VVkL3V46W4VnkOkHR9hFbofWFdB9Vh9KU5+
yqOahRiHULpLrwwMBmNXnpZWt9CT0uuLCzlP2D5oCgXRGBm32A0+ZjF369hOjLUdOyZt1xqLAIpG
2mT5PLKcZSP0Aw8+ajy7L93Y3DeFrgxgol34TqGhDvB0NKC51GaM0mNaxfC3eX2wpEYFZM7Z453j
G/m2YGZjMRZqA2zEWqKLEGqZjK2NryCmXhGEsSPB/ZQuo/CVOnSDgIueewrE7LUkwstdcPPNCqI9
yxgoIPDAgFlUDzkm4z6T8sZIuo4fNOyEmevrfmDOxU9pnwGDCoZMHKHMO6e+e8lrWXyrJDEGyA/G
Sm/GcDXqpb26BgINF0l23NFu5lIUvIxBi6aam69Fqm25iFz67CoIN7WzHPlFF7rVzwvDxUcARvUt
NLKZTAqmPWDMyn/GXEyKlXk7Xg0+AEIYop4MpE9/0cJ1zEA/SI65ljS+4ktkw2Lz/OimZNS/A+7H
fKfWL4fOdoMxLREmQJfy8EZCQVKj+PL00cX+Mhqr2GlDvp3hUVUM8vaM6N8kmkUxmUfJW+cO5SeA
NrX1Q3nvWAfP8YbFVGQm9c55CqTNi2O+/lSteM0qkOmV+Z05/GFVRP776PI5ndLeVcLhGvbqW5E1
R69i8K0AQ4H4Rn0OhDjw62nE2ZNOrUzF6jcInaBpPphbS2MWMiMt7LgTBXQV+EMU9K6hLUXjBK1j
ZmvgCZBtLUbQNFvfo3Bcxkm+K+lF65P2NjpNie8ZAWHCnuEwDTS94tn6ck16nFGfL0tL7S1NbP0s
vUmzEvJBy/DrPDYI6/UPN2P6MplmerQ+PTub/2Aoq1kBkPmakOCO49mx5StMlssoomlTWVqzH3TQ
+p4Pw68pPrsuXjSRt2QtQu8ZNW9scrpDj8yXicos2YBAB1FqqZt+sLNb8Mb6hHsVLKe5SGPc7xOO
UeApjkEF1mluWscaXpKh31rjnQFvAfbqR9yE5jEyHFKu8BbyDoeeVgai7U5ohtcDXM8oH9ZtVz7H
Zd9hkSmeDJs+k6vvJvPi9eIm7ya49o6+Txt62Vf3MZGB90QvvJMQTgCaD9ygNd/aTMdOSXVqc/cy
dAMp2kJsyVOFW9uknEJmbO2N3c7O2huPgMywTbrI3YsBES8odniayWJkB7B3y5hRY03cl7P3ZVao
r+Q9rqUmKLvspb7yVaM4/PDdeV4Rg8rUyAxyPnzDM3RrKfKTTcHNqmWK6EfxBsY5PTYNDl9dJ4Rs
zLdxaJ/cPDPA1FjLUh9fpsJLznWPB+36NcG1ydcOnqcbITRxypz7Jk+fPPjSNgaopknyO6sfv2DJ
gy6pKp0stTbvlCfkdy2xDxQPgHqE5SMgkgdF9RwzBsQaATajn4sXz09SlgAFhyr3iPk32VpkleKV
B/nRseeLByIXUhp53o6y78LXMi+QRf7q5pS+BxlEjmgp6StgwhNP2qIotXBjF7DLprSpV1mZnuj5
HIuaTW0/lnd95Gxrsmuj5j1YvWKnYTjxfW9k0ClBpCnq3W2CtTCuEMgl3xFyX3pL36jIWcZ2zf0M
4hk1qn806nkjRLN0jB56Z37IfEZ+5jpHtxah9ErKYVtnnVctkSoepxkmVgRlnMEcBsM1RwuA4HO+
h/y3skcQwv7wkfJUrW23hkkzlvHGdvqd9OqYc830ycKvFdFhYi8Ka2ram5HBnmreFuxNMRmtW7An
AYmk+t6eIi1wM9151DJrTyDLPuo1WiiAdEx/3pn8tKUh8ND6TbxQ3iHV9AfJlgeK5bdmIHoA/OQ8
tCyiUOADczbOoY2ua0grPLv6UQ+rJ20kvE76cx+xiHtetal0LC3oWwIv7c66cU48c9c6022Zghsq
SidEZmfysJpUkdy5PoSudi/0zif/Eb9pbXGTzjYCM7KFSKBsLWGdlvWD0yqG43Xplyf8ms4r5LeF
Dah42QzqGzcs7+FJxpsEBr4W94T1TO/LtlUX8Ho8wni+TkFFJ20UVxz5C5upKz7Owxqa9Gx8fJ0U
msR8nLinqjSv2tIqexocmxuT8CVrUsrtMENEdSpzVw4TUjit2fnyu3RCxewPlzqJ53uXd0sQhk+a
MexdJxfbIn+wruA5KDMV8FLeLA5m9DADbQlSN4bbAtChJDP0AadpfOsdxo60faJ1JLYYO54L60g7
ESlaNzBraVIKdaOGDVAHYSxOPbV2O7nxs+pRG52tcky8tFrGWgAjzsoE3CexKevosWyv2xC/IVzX
YYXCXR10SB+WrezuC2XFPGJUge3rHEPqOLdlZjH/kHTnqk0+3E67dY15O7h2saE/hP/Q3xvSjDZN
rwfKAUy/0JQRr+NkCAZEvUkxnFAOvsiGTRrtFia4u09Y4Mmp9nHbCrP8RnT91IVmTp4iJL6ukUfx
jRdAUPRjI6O9o7A3Es8FUitoDi+T3ElhY/lvCTFnQjzRcCm8Yr71Ym4pA7+gI23BTnGWC7cuL1XT
3UGLFphze5BVgBSs2pG7oe7lUgNoi+rj+9zE767IWmqo6ML0ysdm7MgXt6rRFSv3XMDDXnKOqJcR
xdnAqrONY+RH3VUpS1Hawa4W3p3taw8NpvctQ5f2orGRI/n1p4yvPA5djgfSj/RUrRZ4N8XKTZTj
z63HvaX0O658saLdxTQJUay8Jc9T9R3m8VbHRe6FxU3XUfrITMVABwUCoOTu0klM0JEAq+n+Lyls
IKIa10rWxkbTuuwKRj40YbF10ujBkEW9GSmhblqz0Jee797O7ATSQXy0CYJq/5yCgYh67yNKWeL8
Lv28lr4XphQrw6QooEflFnvTpfAVXUy21C47L8Qh/KiKvWz1OEBZJY/PYEqcHJr0h3Oj5MhGyg4V
JnE6RffajMAxqUl0iy7VeVBNd1WnJLjAHk2xz2y4axNL06WxnbGylw0sI7b+lMIn/FpDJ1eTJtAm
k/841prz1bv6AbnSQCIkOgsdkVur5qBR1IG5qgvZPEtW6Z0yCPnFjgMrtQ5fWWpPwg/vwdYBokup
HWW8MKA4wp+V8bkKzRfoWpceW9nKUao9os+FP6t/g0f12VdJsZgnIw16XSvWbM5vjdIgGpYS28Os
KBa8V9cIRPrbEuqpMViPHtTDwBm7DSZwQBhQ5YHVgHPKgi4v1v4oHmC9rswa9YRqOx7SeKclyUWY
7beuyB7BIQcirS5Uy/ogyryW9A9e0Sm/lWbzFYbR9U7BGAzTDqxICmc70rS1ZpdHwgVfmevgEba0
O0tLL3o9c6cXgGbtK868v8IYefdhroSLFvLczto3knpMVk/pzGqc2xRyVPvBgHC4LGyxjsyY/ajt
w1gRN9XE6Fwk16GIv1IjWasOESJZhsdIDptMYzNaU14h8c7ppJ6aJysxv5E9JMJQt/xJVGurVDfP
AOrcTd3o+i4fQxOUhNDgS+dzz5Ao+wcOTstomF/4xIE1FHdFgawjA+TXFPIcxnW5t7qkeR4sm8m/
lkGGqktee2++TFPVrqTl3FcRX+KME3ZK2ASYsf1UjyMHDySEOZ00APnNfRrnqzhMXkonHTeFdB6k
4d6Us7pJARDPdXGT248/rDdZUUICM3eZNn3SBD+2mjzHzEX1vETXIJ9nzhd9t9I0gc5OLDW0ZquE
7wM5U1Cz0K+Ys14y3beqhmpn2trWT5mKLBtrVdhXtk+OdQx61x6Zbbag2kPn1tXTZ3ldXByxCG1A
ZGD/DJRla1erd+gZj60zr6WX3A3ICAM4pU8ZCqfC0NN1L7JD0wwnozfWymhu+6i/4QhbnUAUnCtv
5sShSOaKKDtSF+B7LQ9S5AyAZe6ymdVaz/3LAIFtwbszcFH5QQlPcYTr1QmX19lvzJT9c3YOhUg2
6RRtQ5I5uaBYy/sp02O48uWzGEd97QxGvbRd2JkdHNApMzKM3vptxBnBSgGYuQr6eK2x9AyA9e/H
9rkH/ZdY62s3BuBrxFQgtZ/JB9yvig8KYqs21TuGxw33ouxsWsz4GowoxEcfemsQhOeBW303WGd/
Tg+a8I6uXzHzJ/dgcr+HNcn+zACumrcrPdee4ooSVlu5bOqn5z66EuxN9gD1veNqjG5Uz7QYn0jA
Ew2Q9DzUeK8zqDpIzv59mGzmxJjWqd4zMmwYb5reHjCMrSwtlHuqp21Q6c5ilFe6r2gvnU8kc46n
h1xN5wEVKI/U0cKdNww+FFxXPZUJOaCJ+dJsqg424PBqxp/goKMJ59q4RQFkcr6aAnvoDjwUYLfI
zhrWU8iZYCE0bQta85Iq+ZLW7NoM5hg2puPHZF3C+mDK5pDFlPlscSZcd68jf/R679zQOZJmBusk
/3R7ilyUI7MAo/wibzjamdezsnyra1gBvUNZ1lSbItro5nSyIeqFAiWmmRbzEqYo6FuTrX1ky5Xb
MPqis9EXuDcC2N645jj7IWhYFG0bxFjwUpXtvVLgrAFGSir7Q4+1J6srcZ3WXbXULf8ziUkpS5/7
Wx9Y64Ysn+76tk9WCAjqZ2qLVoq6C3Q3o8zsznGdL5vJfoVr8ppzWFrmusqO4Zh2LJMyOnm+3NqZ
2jvNnK4TE3CWrNhmMZojitbaVvJekHQzkvyLOan40dEduRa2i0Zn5qIgLhxuy9lk65MQTJVtI1dO
56mNX3BY9dL+QAafqG+eYaAztqX7knH8WE1tS9KavEzar2ZB8awA0DWO5EkddkqyBo8cvuaFbyyp
vywS/R1v1YM+jNA9w3Ux3+UmG8fGXuqD9xWxUxd0JjzXejNz+VHq9Tqek9Vot6vM1p5t6e6ID65m
lW+9cXias3g3l+n3iWs72WxXuvheM281znmdcA+6k9+aOgrCzrGOvRcdwxRtodtugWzik4MHv/JN
BEyYSlDtOcN00MHE3iQYcgIZcxV8ClPTU2o2ZkDBWvHm9S9oIh9mmV/oj7C99WgKhJSOJMe79ZAy
/DWq6MGRlKE9XMXsA3PWO6iUjWAcq4zfOz1jG4vrEGYS6Grx6IToy+zWuGSjhqMLKxZAYcw/iSKt
VkEpx0UiILBNaFG9j7G+k5hOXIqiauFO5Qdvb46EXZQOHDjUBiEexj7MIbb73ikDLJuy166erfC0
Br4LuIqbxdQKUE3wwIK40k8td1brIMZIyrPNOsH/7DhH26t2WC1XfsLe1RZmdLSH3F3KUXvrZXYz
JJS6teQ7W8onj4bUKqu5ZzL2bzttMpjuHfEEZaa+j4trDRQKQoK2ECkxVUSDBkHif5oea5Mbp9sx
Tm6dse8Dc2D6u9L0rUn1mzKx/OqodWi8OUFDJ+WhpOWCzGWZFBX0+xmBMif++uAnbNEoRLPD5X25
0Cq/Xg2mH0iO2kFr6M6Gnh2IBKRRrRevK1271D1GoaoNqa+O+hZgMuDypgtkYr5ZPQ/ObGnLuE4P
dsPQzqjjm1sYHU9fblbsWyZH028G2263hUip56Sz81A2foeBd/bqy2hVNnxSz38jDTPdyLCs3u2W
IhqLW8RQM0jnHldd0bEhbRHQtdnoLSz0SZSIbtWkfH3ZEw0bKfaPzkNe6wPmrLCob1Sf5jQGgXJ3
69IQzY51h+IBljAzSb4Vk86Atd3C86/iJYiUD33Kj5XhrlE/k+jJ5htDE+1iCAGVeE59mikXfGvq
sAR8nEY8nqkHqXmgcN9PlNJyryEINER5uqk7UkKcLeV7qg8lj7gECxbosmjXWH/NZWWU877QXKyn
WjayAamdZgPhPT6XU6/fxzE2OqeZ9DWScaOgYGz532sj1WjdULiW3dVRYhFzyDl4rdC1NuvRJLXD
NsNYzV2fHDOGS08xUeVlrfqOQrDdTDDVa/k5wX8KJlt2iB/4jNdoDzK8WQFd4ByxV3mUna6kkDuX
qEkWKM+ed+FccvRjZ4/0JutbYP1R0ne7YXb6b5HT5DvHzTg0+w0sWni/SIU4/GtsKetm5rYpJnXk
G+2AnUrbXGspufVg5NpuO/Y5ZhCacsADCMl4xG7gYEUtczludDvBQwNi+xhqrtcFUW3IrzFq4oLz
HI+Mr9z0cR7aIglEP1At0g3Nfe4RRK/arK62EiFLFcx46HdF4w+HVrK3WqehxpvIjktULnMrjGND
OGQth6JjzxTla7P3kje0Etp3zZgotMSyd9aWNKJdaBT12uavQ4rV+w0vUc9/j2CDLal+zCe7joGK
k5yADdBl5iuixvFWzLWJ2dyX645HhOmFMMRE5nT1IaIQtM3G4tVr1PxgGFq1sXxOGbyvmCOcmvHk
sZ+5UMOYdmk1FmvLkFB7c6Y6gOGLnWP18Z2iinWO+zFb6RklqCHnEA+ZoBLqzFmHtpwHGpfNe5vI
eQeiOqKiztP/Tcape2qnfrzYlebfeRYH9kAvHe3GoraD/CCZGOZK/eS182N5I2IvPyt8yAdD+fLV
90M57bPW1tMtzoXiSI29DRe6m2jtq5u5XTAPI7tKdDDFV6TV1qaOtHBcRyV9wC3zbBhUCGcOFEWi
ifZjechLctVkqRgiKbIOzPGsehTAtjnaFxYQhxpN1ngnE4F0vM0xxURLt6abrYbKMdfMmqNXFVp4
p9ca1vOMS6B5LIuhURZ7Ujjj06wN7bNHLXfV5EaPomsAylnD3JdeZW1M763wmNtxWiP2F0Nn+PfJ
TB55NK16NTN2X6/sLolv22xoWIOqjqmcShYZzJec1r2KrcvUJU614WkPo6MYFEdBBWSiIh+vHAwD
cH2gooTzoWG4mjJjLxuoYx4VmbXXdhfTycOgRD1143GMlAtd06bVUDRuYIWpn3/nn9XWB+ymPIDG
U8mNRJJNkcOPOnzBKifgoKvuIYLKadGTVfZTz+HquXFcRXHDndS+F/14pMrW7brK1o/VNIZvvdba
lESonwdVOU9LLya5K8k+rqqMKj6VanYRehq9F6LPALpO9XDdfXuHyM/FSzNG0WK40g30EtRL4zZi
a2HnXGflOD61TXwPFS2+TaMhWhskQQ3Gyxr3lcBApNaKuV46giVyLdwg+kWTc6/dT1K5SCzdV5E3
+mdPrRiplqLTZws6KEQBOK9hQLBxWxf+LhsxHFyMvHQeGEydHwteSk4Lx4jcyCP9Sv9+SIROtVmj
KlxP1zYfqh4tGVkVCPSpedmOhCF82xJ3E9jz50RMYqXyql3YHrOogZX6/bKwnOmZr7s4KuFT0EMZ
nR0gx4sgnyjjlE4jg6HL4uMEcDLmqCWsVz32/OeZNsPGFjCtUspT0YALvqRaxrAaomgiGrq782O+
U/ioA9rMsVMPRars/UDiZZU5FWeZ3p4RpPoifUCpTGW7oWeLzJuTY8yXmqa0h9qiS4kduPgWsUQW
SxIvvMNJS59x67aHKcvD29ZU7cMUR1RD8664QWat08czsSAuAdRV1I6IxjBjYnCmymgRpMbgnerM
RAIxlhUAibqc9SGY894fFxH3y40UspPbiR4jdAm9GC7z5FA6Dd1a3Ewob9j1lpNaFugUjVVZ15w2
mM1vOSyM4sg5r1tFTXlLaRuLZk4MeeH3TPjBrqQSyNCRxdpHB8WVjfoWMujN7zsOZ8jVNvI1pz7b
1VAGWmnbSLGlMXnLBFT6w1DldOmZiE90sitR/e6oGWyuJdgbVRgsa4IdyK/ZTjRAHHXeR9aQJAnZ
SuC9kyd9pp3Jq9xMchje7cwwb9PcoG+VARVcO9wwL+mPVhszlQy9oco8s0sKi7MpeqfdojcB88Ut
tplrMgKmBjrLhcyxpEhc7qdOyS+HBtVCVe58MW29PYrRitB99WLFQDRyuR9hsf9Vbu6hKvjXz1hs
8J4fVc2xMYq7/958Vqf34rP9+Q9d/57f/lT7G7t7+d69/+G/YJhMuum2/5TT3Wfb591//59/40Ov
f/L/93/8x+ePn/Iw1Z//+q8PbuXu+tPQEZR/yL9dp2L/Oi93eZfvH5/5P3Zt/l5+b/+f/+e/k3OG
Yf4ThqgP94LIOPlNfua/k3OGYfwTVBtsvGsun0w54eeykl38L5J6/zRY5cl8exazHyT3f0vOGTbg
bbgOP+ig5IN173+TnPspgP1/c3NXXt4fM/NayJeRhUO7Jyp0SrMiMMNin3XoLyqxnEdAw5b2wnvt
NNrMtEnK7T7jjonFTEXo9Atl1R/lGAa8a7e/+w4v/w7Y/oO366VKyq7913/ZfB+/y93+5xP9NJQz
2p1ZKXdq92mt75EBRWCgalpsMKEO6NrWfSW9BTE95KZTd0RN5dGTbMm6zv13qqlPjQfYfxTz3hiY
u3ChQhho35dua9I6LtxibZTMwvqdu6ZZyoKMxSZwKrpPRPjIHVH4CAt9n/fJq7Dm/TxXD3ORnviF
nqa5jeh/SXhfeRttMQ/bq9mruhXb84jODAJUL9xFRbVM5+iiV9UDSbQHQCMnt8BXG7d4wZWdvlgK
oW6jGR8wAZ+MfnSYbtfvJxsVAFU5flLnnOe5/cV0xI9L+Z8g83++0J+GB4yudrSuGYe9nxJBGhov
6A1+5yj2CDkS5KhJYzhXk0VCMDIEQFGnr1XpAo/DzSzGiKQvURjamIyjVdsicj4lFrRieKN9vyi1
8dKltoZ0N49QnKhip6KaqqFJsM9PzWElJyau1Tz0y0yMeTA3E0uvcB6o39PXdYfbpnF/ERY3r/fI
n/2qP40RUOTWB6Kcw34K1YWm30GWKREi64YveUubm3eywOcd26H7HFrcv5OrXsmSpKthZotqdw1d
KyoydXTP5mZj++ZH73XhZm4R9bhR/mJVAN642cvbeIoufUTj8u9ve/P6Ef/so5t/fBAzzucT/c5m
LzEoI23BSrFPdHPpkywHGLRBk3Hn0ZzCf0orMn8dHP3JQQCGIn2ZSQW6Fn14nnH7Gg0dC8VNyxyd
cfStlnJCdReN6v7vP+o1tvunH/WnrG1c1rGdubHcM7tPxgi7J7PsGaLYaaB7yfHqQ9rcPl71kFvp
/Sxb9ttxpG/ZcQWyqo8Fj8oCB98vkvp/ddF/mpN22DUwWEy4xbNwJiXIy3qerF+l0H/Qa/7kwiAq
+OOYZOzTv9Kl3BNQO1JMPNIbU4vGYS7cvhYvBrfEQac7FOIEA/E/2CVxQhbPLO6jgvpyqsfn8BoV
aVuchHm2seyYXnOevOp5dm/gv6xS9/Pvr82fxqDpPl4X1d/NdLoZbPOpquR+LAlIRZ8+lsKMXahN
xZdpuF8sKT+NqP+2pPxIYf/ur8EO3SZF0jd7o1K7a2HOaQq+n2hDdHAhrvsmWZ96umy+PQV//5v9
4KL82XX46U0V4lcvx7xsCJPNaI1IB2QkmHwR54tWOV8Zhu+lnEbtMYv6IJnSberYVCc0FNfs+7gx
cIaMA7XHPNJf0oYCYCuHbz5xwAWeeBkwD/Mr3t+fp9G5DD+9wxx70vC7ePW+UwO8g8mkfX1t9gmC
Yp6YzUXS5Bsn8h9NsyV7N4+4GIpnacZUVCMSdbxeVpPevRQ9qPuIQqHBntYH4ioIx8TOQY3JR5OY
d+paKGDPoS9rQ1u1hX7ziy/7L1Yj86d3xuy1jYoFyro5YWecETZtS9hclvOgz+YzQQaq7P2mEBka
YlxVtbOG+s6xgdFCv72ZUOYwYXTLZMhiNvs7VdEmbd0PFtptWCS0AaLmV5wP668+6vWf/+5eLEsa
3kXoN/u0RVWp9aZ3nDtCejPHjJOvZmcVceYM4pGAKqGxmoNEdlc5tX62jciBQkO2h2AlBaYIGGtB
kdsOiXqVYWHRkGrbbW6SflXpE7X0R4Ryb75BL0Bl+YbqxrvOyZ2dCAMpyagzSu1OB69gUNyxxYNV
9r94O/yA6P/Zzf/T2yFETupVwqjpcOAaLpOD44T7wvE/B9vYVmV/yuQLl+tgz9aaI9KBksq6zMtf
odt+jFn92d//05Jfep3s4QXXJGxzhGvzVARDwaaHNFt8qdlS+Dh+l1Q9sI3o6ltmiY9ao06b9G7F
68qSG4czlO5NVGYnOqV+/30sOOIge+o5X+NbFYXRM90jIV7GI5Ypgr23dZ2J7RgFbsGgUy0PRY6Q
nuHlhShjtSxjz175HtgQuAtHr1bZxteiLTPz77OpYc8EYhU0BWFx0G/tkqPz4+zlO6sl2s5LiXZA
o98xwaXWQyzf7JAeUWOjsp1imuiVdhrK7jHL3efYyl4HFnFSM4S1Imtbx9FqVLRkGB94/cUD98fp
rv+sqD+9xFy9VZ4zmP1eH9nQtlHz0A4kuOqBig8hLyo5scm5UVoVRd/OWuSqNFcOi+KSNzGTw2xF
AtrS735MiSqpr6f/MKJES3dPqrGjzM9G+O8/q/iLHfrPsFQmNaJmsPphT+f9JIcbdzhZ5FyElVPq
ZMJC9Paezru5HF2DIYlw6RnYC3yGAHw2DG2Ub8aCPnk8M2wgz9n4irXtxtXwV1Lnqb1mW+OdUYmz
aF2xlbO1yUXE7xruaU+wxXGWsINWWfVGGRT6qGkEkyvvMselNE2jm1bkFBoruku5c2TtpXByLIbv
o4lW0SHjQKf977+Hn0bBf7tmPw+FhjPrXKwGubc1ODpUv/OHrKRz3Rky2RkeoMjQY/yg0lGlVdQ5
uTP1pTYzJWzY83uiAToR6QzyqyjzVavjc7EaRhUMc6ApLRgBaadx/tWHva4Uf/IE/zgA/m6Z1CaP
+gmhuH1aZKCEKh87UOKk001YxiF7Ze9MHEgtq+sDSKDZDdADUvr2q6O46m7bMoEhG9txcvFoIN6r
wqObOgt5AzQMJG9ZdQHFGsY7alSwTvuL/YzzF6v7jz3o7z72RLLnOqxV7Sn6dstZAK7NugzLYkuy
cPDreWXFdUfOIiX3JkhnDniuiZYQlSui5pjOyZ3bhERGp61tEFisbfbMdZ7GK8YKRTAAwFokgNMC
q0g7WHPEvB1G2Ram+T/UfVmP2zzT5S/SC+2ibrXYlmW33Xs6N0Knk2indmr59XPU72DGzVgWvsbc
DAI8QPwgpLhUsVg8dU4COR0jFwGAh55MIwHUYYbntshDgIhkdYfiFBBK48HRqgQmg8YZ/6OSUEwB
ePJolS1qGeoxedACBH1z1Bg0WeFEabNjY/ZG6ugcg7O3VDOkxdTIqwI8CgvUhYA2MLNGB37PUBGp
DX77xgvGNIUdzVG9SIdtw/TXNp2RfUYRugy4RlvOspm3jiibla29tFu4AAYaEnqHy2u5DwQoRpUl
LhPQbCtx7uXBMKcdQdcVInlnFN2fQUWNTyuABEoamtI1ade7hdJoblVIr1Kj7dNJuWeJAohBVOF2
ominQWYHlQIsQsHEffuTl24ln3W8Fzul6EuqGkmZ7dOUvEas/dkOWANN7MFhJUdn6Em8oqL2NZej
0wB82zZDlYoT6wJeYyjwZZUcn5tceh+T+OGbX8RFJgpcLvQcKTIZlRSfpBFoIztmcvsYKHSW5EWV
iQx6Lxm0IG4kqZKDKrt+l1XCvlaLyNjCwQDWOyFndAyDKUaZUBCu2NVS3ocv8pfZCI29Viz3YTRB
KUsB26KmgL5L+eQ36uQBzF0KlAn1Uxvi2jyZrQhyMg0E6rnEgOEe5uefQtwIfScjnyAWcNyAIa7M
3MJpKHHhhgSEGSk7oFapmnrA+W77YubYIkcDj906TJ1000bTiJ1L0f1Knwu32s+7zsX+yQFLlOQM
LxZQ+oWWabAVcw3EbTHxgb8D1bm4bUzTqTQDxSbAEyTBc9MEWxnVj8igAII9KUCER62/8jkLh6zI
XTux6FpfSdKwNxh7VpJMt5WWAWqXDucgGXCra5BH0VL6B6+5PoWXAEXmo4pbP4ifJ81VWmAmoIT5
UcQqwAp18q4TYUVg4/MWcOUsQerxS8iNfSmW0D3t9l0EeAZyOOHPADHzX2mUzD1Ep5GUBizYgk7w
BgrgfopsWNY0P0WtONQxsgGQ6wRjPUGJHzIG8R7RZX/fhnoMWsjsQWOKO+nJm2HgQoeCS4DT2hUK
q6UTm2d3CjIBjMQt6fZSxZ611oS+J6AfQysQq6zzNyltf/YhDgi8x+AVqgUkF1RvwGxGyClEdzme
KZsYasRqZyibcMJ+xyTIwBDFf0KKqHZl6eclvja93E1XL4UJQqxat5clIPpNMTlKFagIY5H+VqoO
t6ciPEH2A/jSCUU4agEBehx3hkjwZTk+Dx72aSI4sKoA2p0IzrreEUq53X5+3//rRP8x/qgLCMW3
/x9k+mURnuZGph8FR3FZxvSrUObnv/rfWX4UtIMhBLwIEjjzRBDn/t8sv/4fJP+R9zfxbDPzfv6f
LL8s/gcKklAmAc0ZYH2zHk8DcDXy/+p/dFDwmTPHEHSrJPBP/E+S/NdcCUiweUbxvhUAN9Ty6TDo
vaf2w4ec5SoKtwArmsB3q6G8ZRNM4q+LqTn/d59eJvCvpaDQGy9FR/okDOPAHA+d3P5WFfo2xMMP
VaRPgq69J1K35iDnVARvJXM/nBMSxxgPizCMA/Ab4+QOgSndI6kY3mVJ0t7rvTjeF8GMV0FY8EI1
qJpZIPWNjkAWQkkkK6j4MMgT8nOZlmdrJ9ccH137qHlSLg6RkCpjH9fReKCkfjdBgeroXT7tlRKg
/dvTe+2YmofNOYeihvhegZTqQRKCXWWAR2oCEr8Nx7dKKQz3e51w4R9Y59JeJDnEZFoCuDTyGkDx
i9CbYN/sgMsvqXmCQgqtYgchM9Pf4IUYgJpJwB44kfy+ZYK4MltXPf48XbCtywUxwrwmRlz2B7M0
qmc87Bcb1M8Ckj7i9SMqGtC0wtHbVY0yoRLAp3e8hHQbGCm49mMUyIBhOI5ewaBAoBYNDoCHfjBB
rNDUcnwCYEaRLUbUdB9VrFoLRK4FP/Mny18/GWgkJVeilh2SbIQwdwsNVa0MxacuG0HBRJDNRPEd
0fMfo1wS3DJwmbFoXAEodXvxF+eMi74CqZ4CTSjYAc8JNrB/50ppPgpx3EFHwyqzyu4q7dyrr0Qu
t3jTRJkhHsIT09VY5/UAauMpFBlM9X4K8UhHk21srEzNkslzSZKpA5OYiqMb1V6+AiBZhyLI22Ne
sCqeVCeqw1rALY0dwvKlnJF/eKFLgjuzXrOoBcfw+dp54RhKhhpSYcCisvEshhuRHJPyv+fxf1+1
rzjchVnROJ8ji1GvywI8glq/qOVR6VeSwEtzwnkalTXVCOwEO0REtRPUIOHVYkINSAMU9O1ZX/py
zs1IgNYXcjzPunQvonUWrOh9Lc025170rhslkFUSH2I7iQsQ0bHJNS8FCmzly5c64NxKbsosjDo9
BpYCGrN0fllUc7121XY8356bhWOUFxrQsrgpK6U0/A6VKSoKLK0gNn+jEn4/aeFcwbjGB7q0zJy1
iwURKYhciB+H5rYFQCeROyS+UStlrCQ3l5aZM9uuyGMRdCvEL7tulw10WxX5SrCx0DRPDStWKjBX
Wkv8POy6TZKKf5QaKNHbS7DUOBdhAJ4cim2JxgNRhheLCOgbR3GFR3BhB/1Dgo6UQB6VhuFLmnQY
2/RBr5NzMFYPt799qXnOeFmPOhAhDgw/jI2HBloqiqrdiyDt+F7zc7cX7owNQPxByUj3ix7VhlLg
g/YLauvqGmhhaern3y/al1EuMQhlqPvV/MScPgOQtfLlC8GwylluIlZyTyeq+xHVUelQBy9E7d/C
NLxrIvlxbMDVEJH6e0asyl+HIQRjS/sy0PxRAACEhto2DssPCNM/JLQEFSxQmLfXY8Fb8DozzcTM
SknRUVHkfiXGG9b1qDEOAm8mqpuLaNaig3kDXYlwVc6YmwbAiK5HTwkqY/Fwhm7Auwl9W5DJtDEe
AW8PaGEDfIqHX2wAoArSnhTopgUqykIFuWwRZVrx3kuNc4YN1Tnwo1TYXXklqHtU29b2iAeYldYX
Zohnbax75KareP50kGZm72p3DMs3Nq4406XW598vJiZDeWgT0xh+o7in7RHH3KbHg1bXDM7tmV/w
HApn2qYJyVQ6wnPQQo12ASv+pInQYYJCfSV/tDQEzrhpDiAuWEWwWeWRbsM53sK1aS57bkQUqcor
67C0ypyliyaqANWhN/xWRy2jHBoWKovfvzdJnGFnrIpAnwv1RRYQsgsL2cW929wO5ZpW79IqcKey
DCIpZFVClEYJwOMWeQCCtxrUaE2+gppZmh3OjqPSFCYCmAKYDwCFyETVSfX+f0Y+/d+XMVxheMwM
qkGSEWxyui/JswhdjRo+Eibfi0t5jAteEkpJ703drxu88oOMrqgI0Fm1VAJxXa/4n4X55xEuoxIq
pVoYmJ5YeUaO+42F1bsM6OA32+fMGCJPfdiBXN+P20MACAWo7Cyxm3a3t+eChfH4E1TBxkWu6rrf
xF4R31dte8pVwxHAInO7g6Xp4U0YHChFhEuon7fxB1Vq80eehvVjhtLqFetd6oGzXoB7CEGeVfeh
/hM6jYJkcMEG2YnqoVjpYmmWOCPu8D6XNDEGwQKUfQmbWgYzGqAIU5C4t6dpwch4jacahIOjqpfl
Qcu79kUJibI19bTxbrf++Rxy5Sz+vMBfnAWhggLCTtWywxRloZ1oLYRgApZlP4kuBHdiOxivLNMp
lIXBwQQ+LyLgHU8yGvYUJUq78hVXkYswdh4O0AQikQLaQIypbxI3C/v6F7jkOnCyhuBI6fJEQQVv
JsYABqiCaeHNEzGDmQOHsc0EWd2Cimb0IzBS3kOrWrOzbIKoLdjwI2eKx+AcQ55sL9bBCLZBIXDi
KMDrhxQawqFk1eqhvRAW8m/5kL4aaoh31wdlqKHpO05GCNBECQyJxWgED4laFrD4xVmJstsYjHtr
t/erL3Hz9HHX9zRHqWEFRN0B7ygO9NB/DJUO8s9gD5XP48xglkbJXlCOLT6rLgyIOA+ghwevjKRv
QYp51icG3Vg8zH/PM/Ev7kjkxIRB9f4QMjzAtWqleRIAvneJCYXhlY07G/GVjcsrs6OyJRXB0JAd
JA1qIncmUBSTlYL3E2FGre9oGoJfWkVTkaOPDPVlqI1GbYWGVFwzRCj8zcvxAOR8+3vlg657G+To
v0ZVOWoOCxmlIz5KfjY4zJ3YfTiDtc3C67uFnrfJis/5fI7+d+gonf3a09ilQQasIiiiwSj4I3tL
9xMAMmfDbT6UvzroCUJbAuPEr5WBXd/XMh4QvoSLUg07KkJ0h7fTU3g3OJChBVwBBVTWR3IHveMN
4FWDrbjRbli52V53euBH+NplYiZ4siyK0Q8H9RHibE9jqz6tDGdpnebfLzyehGKFQUZ46lcubsx2
7jb2YIFhyFJsxQaRn1Pba2rU108HmczDu+hKL3MUafT56Cd9f2pL46zGKYqOSOkKPfBYtwe0NB7u
lIO4IOsmM8XyVOI5EYX7OgZ2auZZu93+9UFAaPDrICDxXbG2KNNDqQoQNdIlqJ5rAcocwXbkduAM
dW/38ykn8u+2Vj6BixezhcpIsOQqJj0glZr+hLOnexEUK3tIvUrACcmgU8EDTW01egp4O/wJBOCB
VMM1vz4UbMxfwFI67Ok4ln8ZyBxzaxQFlEuoAYqgQMvG2FmFuCseYw0S+pDw6c/tAG5PlHlLP2jS
SnaXhFNnR2Y7fuuWAqb1r1MHYhWV1ToZ/ARFL2XxswJJTt5NnhkWK5O2tPhcjN+o8HojMQe/rb0M
VZU5CowF+fH2isye698FkQkX3/eoqW0ylNP6HevatzYtoc4NXl7lBAUj/QB3N2yqQNI8yJqBfE0x
pRWPc31Q0Nr9Om2QowCrpYQdl5knKU0PUXGGrOVKXndpO3Mz1hHQUcVqnh56VMxYcTkWO9TDqahv
NEO/FsZyBShw3YUpPBYkhGDY1CVFemB1q9qFkbml0q2lFa+i53Hi89COtotM0k9g/ivNYuZztpUI
SerprwboXQ2+GIKcr26Bg+T2TliYNB6t0TVFUhEDYpk6cKNiXNuq/EgBcpDXnmWWOuDOGLMrI2PS
S3SQ7CPx0MaHCGQaFNZ6ewALZ6Yizh1fOBeKiuYW9GP0UMpk+jWNE9nUeCNzmkiku6KMwDeYlPRV
6bXxUCYxYkjC6B4MrfWzHgJh1pYs2dGqzldOuKUBz3v/4nskFZIQVFMpKkrJDpChU1mIH+mggaQc
pau3B3213mHeJZzrJiWYMKOuLg69PTjZptpC3HyjusZGcsCz5aCS3eo9tmXb+ki3YAh3bverzA7i
X8cBOZ2vg8PrX4DnWITzrTO62uaXZHXbyg7dwv7DrNfD4U6x358fQX3igi/akq3H37+7leBowXeI
nO8AQ1+rmMXM5tiDEHtgqlUO/T3wsJvbY1sw6xnscbluIGkMFHEYkkOI0uB3OZbopi06dcVpLORg
Rc7jJuAdisUezikUj2n4pIEct1Tv0+kD8fzt77++76BJ+fX7sxqKjWGHHjqhpzbVQJgktqrbico9
kYs1/3R9FWReEnEwU2pKwM0foCnpMrABAr8PdttvufDPitbLNRiEcaQyQuCDPIFzQfjNAOcn0Jgv
hZX76NIkzb9fGKfYhLLYzGcEsJcgL4tBDAwEqHEC3cTtVbi+i4AE+NqBhldnyIB29GDGyn1DCw8y
SivGt9T0/PvFt4MymcFr4Vmlr/X2IGjgdROCNdje0rpyht3gKpdIOih2xaj8A/qS1zbMvUBO5BWP
tdQ+b70i9icVs+QAZvHjEMt/kkDaAyf15/a0Xy2qgjSRyVmvMRo0BCvP6AMH7qRutold7E+vuWOn
zJl2H+Bv2kCft32vLXCp/6FbVAPaIJd3M1tZGeLS+nAmLqF2QcgHXD9UQIxiUYP+bb2ybReaNjjb
HsdUARYRwWBldMUjNCfovhPVzrk9eUutc7fOFNwIVO6MwRfwUj0gz1tO38tUQ6j2654dCAHeMNAH
f1TvywIUqah6C3a3P3vBlg3OlptUw/uSLA0+mY55+huiAWr9BvL/261fd9iywRny1IsFcDuZ6Ufa
71EprRqcczkEJEDJg7zyy/c6mVfkwqRDsGtHpjkO/sQyN4fIOSEHzcw3owoyw2jFNpbmiTPtrKFS
WMa4Rhod+J3Nj7RrD7L6ERviyiiWOuBsm4EFFpSc2D8S/PQwgXS8KptDnZa/RZF8D1Qh88pjY1+B
P7Zlgx+AVIB1BxOk11Obbm4vxIJ7+gcFyUDHLbfa4Gfg/xEyELIi9xGtRC5XC/TgnHjUI4sYiI1L
yDao2+Av2Hv7Y3FsHOaaf5snYBAfizXY4+wP/g3PZB72mII0lZSYJz/yWtnq3elgbMDw5lAHzGdb
4xictH3+m2wg17rNVzpd8B46Z+KVPCoVYnwMLmPZptFR9gmxhOfb67I4dfOeu7CQLNJzUQgxoqq2
po3iJBvdEz1gXA61NfqZTVbWaGkUnLnnIJNXgh4bIJZkp1R/zOzPt4ewkAKHTN3XITCUhZKh6Qe/
MZXkLm1K8yxR3ONQ/x54U6fpkIKIlXQTyQwc/ZWeOWQIJE8CIc4jSFu6Lalb8wCSJ6jomJUKss+y
93IxoCCrZqmd91JjS2Ok3JVJHztI9oOLHBIs7dpr1OfD0LVdxTkQwHRDOkFNCvlP6pH74Udwn9/p
e7ItrMiG2iBAESfjjlngWXPSt7ax9I2wb54gKLsyhZ9IhWtfwHmYSUR9I/Lggw82cQfGaQvWj8zL
rcI6PbkPXmz9yjb0NFjbw9s7WOJtbA7Rej/P2b/5KoSqUTfegIbCXcvULviLz1LYi22p511P+roZ
fFHdRODaM9mzJPcrw1243UFV8uuOyUGMThodwxV2jTs4gqXtAEq1BPsPFCrgOVoX3NcWBCCs2QDE
lRNvaZZ5nKNIOwjRqrC13p42KKK0hIM2Gx3+jO5o9/aIP4nXOoVlWobVuJrTWajVtMD5ZWXIiqPO
Z9fuuw/zZ3KnfwSoGhotzUah6YqRLoBPobr1dWIiNQQjZYEvrLELpEPo0w2Eb+za7TEn8SHclq6O
eycoF1www6w91C0stsZ5uHYQKiMeOiwHLKsISwdZRl1a8XALjoeX3mWdSsZgNq5O3QBHCf2LFbez
cCprnEdLgg70BikaZh/hC7isrHkjKU53F++C7U8UllqoD7SY3TnDX2U/r9QehIhWeWxW4rPPN/cr
Vqtxjg81rjQNCL5AQ9+ohnLTXYSsfOi2u+AQHAy7cqBLeRQ3yL+4iQs2A5e4itduOjt/XbNUZb4B
XPsKznv1RkVRg4QQtL8fXdA4n4I9O0yOBC+SYfcwH9jkB9mTvXJHrffSpna0b4/Fqdw3J3lHbe2s
OStLMnd57VM4N1ZVbAAPASbEqJwBDix8MHCkzfmTdlfuUpjVT+FnAPLnO5QtW6YDouanarfWvTJ3
c6177o5UM4rbA513hKPaP8DPZEHH1Sbb6HdyDncoUYLWn48T8DnYkBO0Tt7VTe4UG6DhsDqSy1xw
ijpr67KQtwO32FdbHpIpI3E0xyqxJZwgkoday1f9bDxDNq4/NCfU2fySzrdnfimM4KGggjmZAWrm
EWifjEd6hq7CEQkYd9xoe/mAVV5Bn3w+a1+Z4s+q+ItzASd4n6FqB5ttXx7oubrrt8UWZIwb8mhs
J7yjaTbIqV2wB3nj9vbYFhwIjxU1E8IgNoZV7SMJ4mrElsJsxd8uOD6VC77GqSqiVMSslZ0JIoYt
GSN7RtLc/vCluELlPJQIFRNwV+MQrTe0gMSCLd9rXrUL7/Kd4lfPKH79yLSNegLlu9v+So+qRXGU
02P0R3lb+YQFk1A5F6VTXCKb+chjm9GmXumRbbjrtpmT7pFA2KZ24/TOgM3feQROqtz2K1Hz0vbn
oabiZE5yacoIbMHe+KM898f0WfbGU+oZ+/Qt28ePbC2eWNz9nN/pAhZodaEMvr6Nd+xJPCaPOmJo
8oPsihOFZtA3tyLnYIiMpJESYEyhNjpJojgKCFhvr9TVCm7coXhoaQ/+q5FEaDs6DBtonP9Agf0u
3JND7Imbyus8kN+czBVPvbDxeYBpU3dUAop58M3gZJA3QfSC6vV7A1G4GGYgDSmjAYTJ4n3+gDRn
8Dd7U5/lt6qwwIgcWyDCh4YRQfmot5b1XBoOF8AgV04UIUeXVT3ZY+wHJtSR85Wc7YL/4UkCgTbt
IQaFHIagZ1ZCt9NqvdxSy5x/aCQ8ToUREjyQYXSF6FfeDiu58nmur7hphTP7aughY4GHDJ8xzepA
hT1GH2LyXA4fKlRhSL1m5Av38U9aoovjYGzGqIxkcY6o1b3sQodukzjCQ+nXLthivGQXb5Kj4VWI
ewL39v5amjTO1qchwNAqeLRmAuHIM2A6K4fBQjz5GV9djEWKJvCGgiTZR3LHCsC8Gqq93QaKA06x
NSNfWhcuJhChwtDqswOpnelH/B7eyft4RzeSL9wZrnAsvPAcPdR3dB+s3HmWDmwejApMaE+MGpYe
/IR4AnQPpCftNb8vniHFA1JCe3CrzahvAx/aex/Q4/Nur9ICJELmcaqGCtSCHmKkoCIBp9Rp2EBd
0a09xZkDZDCcb3onuiv/pl7ule/mnj7IgK/MkcOas15wCjyINYf0JtULrGfT9j9qsukj7djIzLk9
wE9TumJinwO/2C5KFE5GWmKAlVu5YHfClb3Z9scG18Xa+fkEAn+E39qvYpseiUP9Brd2XNOt+k/m
Jj518V/XPGfHteT80mg5X0IYm+oJdJoADw6QedZQEAmJFwhuGZvbA16wu39I0XpI5RQNfGxtQIRj
OETpn9sNL+WPPn+/mMms0CB7mmCLorrOFU6oS/HLzeCZm+Q07HQHpCpHaT9id9DjuMtP+q6GS7nd
99Kscc6kaSAE1fZYxKGVrKZ8jzUw2pgrM7bUOBctgFF91OsenqpnYC6e61SnnaBp7u1PXwqwPnMI
F9MW9zLEwqCs5Csn7Uf9pL6Ix+yx9oNN+xL/Nl7GyJJWosgFL89jXEN1MqM0RU+GGTsiyBjaqLTK
4JX090r81wDCdZLY2mk7u8IrdsVjUY1cDnpZxG74Ids/of7uPP08phYu+Mdf8X7zq7A2sfUQOcgU
ZdZgm1sdyV7R+guNNMTOf/2X+8x+uT3DCzuex6aCLi8tWYfDLROVv5peuYourTS9lAH7B2cqaBnw
vWi7cIu/SmYP4FwPrfG5fDQezJ/0rvGqTQJEn3Y/7Jmr2bqffC+G5dGnI9TCaVVhMbWZ0KjurAKU
7LcnbOmw+dyqF1syCMA6KU1wucEzJNHc7hjvk1PgBagjR54SQnFb8SA7FJfDDPiKh9u9LpjZ56Xg
olNwjk2JSBGf9eJRhZxb9D6aKxmez0m5thk5/1ACeQuCRUwW2wgndtD8+D5/JodhX52xPvv4BKWu
lb6WdhvnLUowShmairnrhs4uyAi985XkwBwFXxsEF3RAM1AclNl8p+S5QI2aFGkO9HZcjUygil6J
OD8hbld64XFdWVKyujLQy3BSTuO+9EwL0Drk38RT7QYft9d6wRPxaC45B8ulOWCtRSk4sPZOrpB6
E00L/DsHMES64qhBeTVfmbiFJeEJcxocDXqeoDetfCqV90pZaXdpFPrXzFDOQJImyfMNCexl2niX
gMFj7DUnbx6zqLF1NgsyrWyrxXWZzebCPJQer5csGBAYZKBno14NiYVmLkoA/z9KYy1NKixZfTYi
HerD5y7VVmLdBbPkEVy9KCU6y+DhuuAc6HdJ8RKSbyHQcBh8HRI0xAGQMLAudTc9l9AJ6g1jP/b5
fSNkK0u0tPSc4Y/KmJVD0UIsImET+Lxp86BJytrGWrrs81isdMqCfBJyw5MUpQ0tKH1EW6Z1Cug5
JN0TUEGyMTIKqsgiK89Q3YSCHOjl7AQSE7vB+FPJQWsrtKigQ6tB9AU8eCRdOYAXvAUP5KqDzoQ2
vAoKa6GHoPKbOTHHnO5NMPgqcbgSvFzfHBKP5dJTcHey3CRezXrlFE2yflISHfCApFjz3UtdzFew
i32vmyRt204yPVST1O89pCTB2BuHJwVgw5WjdKmLeQovupD0qSlK8H94GTKiEAcMj4VY/w4hXHnb
232iSP71qZLJOYoAui45k2TDU2RIqssqZHKyqU2cSYfYuNTH5HcsobqdqAPZml0SPMlFCw49RpSd
EhYV2CLrckRGMWk0T0YlmduoQXOaBEWyW0GN8Fcp3YjArm/CEZqQTVQ2L7ksFk9SVNBHedAjnNxJ
tounybyX5RTaLSpUeTI9rD1oA7dO3NTTxmhMcN0mNHaBQhee5MlIDkDkAUsyQHAH3gVqylBSMOPJ
mqYKL0xiuIcGjLify8+8PE7FV6kuht+6nBa/jBSCMpB3jcDFIKMIx6vUovFUUVJeBlC/PkHVqnZz
UdPKTatDQwsy5rJhZz0yKDXtgQStQD9qyChVxJtTL25SUEcC+JukMiIO0jKnyTvp2NAcEsFDa5RQ
MMrxhBeGHRScKtMpBhMELhLqsA6jUbT3gjm2pynvkdsexPrH7YVd2Dh8dUVmQjFdi2rihaLuZTUw
rWw4Voq0ud38dROWCOcfs0kPqyolpmcOykRANt9PR5aCox2v7alLddlUnaKnkXe7u+u+UuKRK+UY
N5CPqlofLHBztS5LQAetriQwFqaKB67kfWboVJNB7iw8CfmdBN1OfcXTLTTNQxnzLoCIRwOWgEaQ
KxiWemgjCDkNTfi9ZTbnCbvwD404lvEgQw1gEOLczgqw7VWZHNp1RUXn9twvjYFbaqMNjXjKQsED
gysUACEwFB8SqbRvt76wkUzuFFRM4BIgXEe8LumesG3Abx3oO1Mxfo4l5M81vXi63dHCFuLRjRRq
qLhtmaan0+xcAm+QZcPKSb4Qw0um+HUVGMSYVQi4mR5VmtwDAyuzs7aNWmgCtTgOAl3YphAHIEpj
mTQPrJpmxQ6J+FBBNSbCchB79KCeGps29hmBN7g95NmHX/HtfNEdLWSFNYMApVAqbcdsq+o12LQ0
FCasnB4Lc8rX2jVtkXRmZkCxqy3PUJO0pWJcCSqXmuYOPmbIWtxIA/ECTYewOdQELShY6yutL80M
d+rJRq+JoZHBLoH/sRMQPFk9AShHbE4hVLxX4tOlMcwWdWGcaZjRgMWm4aWN/hCScScWkE783tpy
dtMWIbAmQhF4OHfIURcl8qIRKEHXcik+GJO4drNbsH7C3RkVqG0DAUEMr5xFqKUA+jzdbmi/FWZL
fBFV2ygCg2SQ4FU4ee0x16snpiuKJytt8sZEYS0jsTAKHvwrBvKEqgvMFhhUX6lGnuI03hsx+/ut
xTDI14WG/F8ek0kknjgAEDIcJil0SLVPh5VjZGG78hDgOlWTBMDZwDNVUOv1WqbadRgcq7S+m/Jy
pZOlOeJswlCDqADnY+AVo+4VmUQtlVDQ34EL/nuzNHd8YQ5JGkyprMHVp+kjxANtKu2bHIgFbcUN
LxwlxmyGF+2XYi+lZg38bA31EpuwCm8NtDm27RDtAwWWlxlrojVLC8KdiRkLjLhvBskvtZchhqI7
BJtQ0gHFxpVcx9JicOZdgPk9gxJW60sBcQuKqFxuI1D5s9fba7GQEZd4PG2smz1UBqjkV0Ui7Jis
Fi9ZYea7loH031CM9DGtJXC1E2H8O6p5dYKAL6q1wZ6O7E7fRucAO/4eagg6xM8DSg5KTzsQtbHG
KsuoPxe6OXagt58DBjHsMxOa0FLnQThEWytbm63ryvHGI3UFKTFbqAyPfhokmt3ljQNejl2tlAzy
49U9KG9+QCpre3vCFrggJB6jKwomzaCBLvms6AzU7gf0Cfc/iHJ0atlCYZOB0W3sUKbrBIkAlFiW
9JDbVozO7ntlzY8Z8wa7NmbOSNusDlWi0skPjH4ET4GqV6iiD3CjdtQgRmgxEiWF6E6GcLOvxOKn
1o9sB06Pxmoq6LXKdYhLSoaEgFhIqjUNtH6iBgSZdYjY2mnbkTtILcfvTZpnkLpvs1MOjfZ3NuWj
1YdRcAqqcXgcDFV0da1UartqpELGLUxBsDNVta+NAz0DTFOeUbNn1lYC+tQtuKYgGMHo+MJIO51F
s0kh4FI0rigWrIEEV6dAWkjo7iFpb4KvvZS3oRiqryMAu+BdpsOuqxtti9RctYPudgNL7mVHbLXc
oZXSPo95nnWWlozjwQQ71B78A9OmF0QA0kKabiWUUNiyOlIUBmTqPa4urQvmRSWyoeiDmnPwBkeQ
dYW6deHkRYP8pZFCsW9itPejuswhv0RlDVpsA6s/bm+nhdBA53xhl4KmO2as9fUB+qwVaIsdsAOR
73kPHi4d4s08iAtW+3UefqDMe5/oJrVSbIPvRR8866sJGaoyxNXbr6S3Gp5Vyo9F8B7StZqXBVfO
U7Qqg9pMpa5XPs1wCQA4awPpOcMWY2OfGMobCueevrcOXHjTTKHagDuZeGaKJ4VI/NkVwYqLXRoD
dymAJDU04NtC8mmIrEYLdYowL71YZadxJprvzGTzrTHwmOO4UKCvPKfFw0F+TpTiOY8q53bTC8cQ
DxYeetoDG4fMLtwKckJSJnlUBAdXBgG6la9fOEp5ENcQBa2WmZ3kZ1p+L9e9YMWd+MKq8h7a4O/f
GIYo8mVOBZ6uIbIQQlAPonlWAESVAQQRxCCllVvs1UGgA86c4VCbutVUaKfRyVXNFySbbCU8TebL
9wbAhTbRVHSDAhqoPYsPOVJSefKhGtPKx1/1Rfj4+ay5iJtyqAhVXU/rPRgz6V0rCPUmicJ0ZQtd
PaXROhfJaDWZ0qzv2X5Ati6Uf8SSYIdEwtvTRg1A8r+WxVkaBWfJOEO6Jh9yti/MbrR1sOv6SVII
K7t0qXXOmCO9rpUugQhal7Pm1IW5uk9YXK7M0cL24YMxkZUZcCxTsieisJWEerSRXTsW1VTZBe6N
K077qjGLIh8vNSPoraEsVu4TaGwVUKC2JyMAqWg9rBxqVx+d0MHsCS82km6AEU0Z2mRfyCGAwdDg
Cy2qgNyB4jXoV1JGuk0qaNT3RrRRyoitccktbDGesl2hut7ipAMjQdEQK8lQPQE+GbsChZql6VHk
mMCv7yOBrLFZL+wG/vTuAzClNEmredAiDqywIK1b9nLxnawKpnHu9WIaITExZRnESvdMyaHkFlWF
h5Ca7G67kqVv56ydMdEUmjHN94WBtxao5FYnzVTXKtmuc2/g4zlzV5H/NkKW4D2hHn5LkzoAI6Sd
MyV/kEBEbfVJ5QVtf/xfnH1Xk6S41u0vIkIgA3qFdJVZ3nVXvxDVDiPhhBP8+m/luS91OE1l3JqX
iaiZAFLSlrT3XmaY5e/cYZeqIf88a/HWRfDDK0470kITB6qgOrGRaBUULO7QAD3Q6pKF7Fr8LPaA
SaQdjAx4fhQ9hcdRnlmYNWdOdQvh4uzC7Ky8Y3mWJ3XjjkTYFoj+Fxvvmg6EBuSVn0/92sPP8fNh
YVVDDZ4MdeqT9ZJ5X3t5t0kyVt4YoS5x1FdW15Lno0pIHvFW1ie3CW7aRFxJn16oT/w/GYb/SX4I
WfJ8qGHFrLoCSD5ujHP2qKYorho1g1Gs+3u4dZmozmcRodlX7RPo4FFYyXQQn1XIehicB8bQFKbd
F1nnvQWkoT1M7esJDoDwn20OHhHFI5C4AYkmLy9+p8htTCiqqrmlnhLXlUs4XA0LY06ugFBsqHg3
RiQIslPLUx/WyxI5YEySCGYZ8kmUnUU5PvUAvy/EtCvnvL0ncZ+fhoJkN5o3/pG6sADIXSj1NYY/
wEsxiwqYQ32jhMvdNFKcxxl1nzuT9yGBLdAuZrwOIjaO6XOeZuymtYbdtrHnwNunEE+jqmATJst3
mSXxT95WkNonbgMDKkL2s3Dc3/CIdr7ZAWADUXNYMTuKjTuHO5AbEUPw6HqGV7clVzaNstr296qu
3VviwNeh7KVFVw9mPkGkMgiQhl0c6GueQPY6SiroNmwBrBIvWeK48E5zXIC2ZOLdoAmWb7Azt3tl
JRlDJbSiACTHMMdyJ7qtTFXdwrLXPM6+ZEdeG3MXT95wE1MIZMRTOkQjLLxu0IWWDynpxBV8C4tT
p2h+E/cJf25w7djGSqmzIhrdT5K7PwbpFkVENeSma5UUEG9s9FWmq3YHZ6nyVzGMAA/JSR/8gMNM
cKrz/WBJs/dnLz1QNHV/BsxpwiTlyVajoj9u7cQgTTYIiOmedfJgYlp9L/BTQNk0g4TLEe3lGQiK
rp/TIYf0LA/wv8ZuFMzZfSBSj4bOTGmUi0ZnIa9Lke27AEiisiqx+Ozc75huAWCidDxQzF1YwZRx
77Uz7pR80FduB99F1YzTtZFNf6pFksJEU+aHCj45YcVqtiEVNWA5ps34GpQmuZJAFj0kBoI+Yyzg
I2w96u+ggdaITaBLb0N1lZ7U2We2GnwfALFy3DJBxHagJNjlFLbGPm+Q4Jlh3o4BTMq3U93HyN5x
wDq9cu9gIA/tGngt3qCVY9/gYwhnhyQ11+hy+scapq5XeVaNBqwX4obpTMUQWut3OwEQyo77anpr
C8jvQoy/PdWtb+DVV8k/Uqn61phqBKUFDuEpTtmxdTfatl0f2bqqg7CsVNluGphbwlLWMr3zpoCH
UyLmbzP1vG1cEfY0tAm7zWsXSh+Q9D+ptJjHo5x4CS+Utui2ZZYSdAG8Iqp7KHXUbZ3svRpWXwLm
k/uiAMAVl0qFasKQP7luoPcyBkhfp8ljgiAM+Rz4G6GUe5o97oQ2Tv4KIfyIEuRkG54W00YH/XTL
eyg+D2p2oQbY9GHR5SCUGyDL4flh72E3ECRAavTBn4yyhJzq2sLQcighaJoSAjlP2Elu7NzBKaKP
PTeO/NkCjYi5+eVOmYE7fO6EvZ+V20x1/OQPMFk5h5YcIiOpuRJQ24Uzb139nPKmiOxgs6uGMrNF
e7iBSnuV/on9bnzLiZyf0zmHDz2rxz9WtORGANbzE7WX/qoiVRkJmMsfUrju3Om5DaIzdX1jMlfe
ZHma7xMZtLs5ntER91NOQW32bHeTDtBNGHnrHWIeSH2ndAydpaYmOqSWAyrEqrr56QVlBmgK/lWE
kG0TJExyqBGDy+Gpm05ObQV3zxEOlb7rd+xE/Qwl3i8djf/h8344Ggf4WVSO3zcnMXaw6ythCq8J
dLNZob8EFidkyb4xxmd52lXNSVXJTtfdqYaX8VDzr2UoS76NTxNfQiy7PnV9TKGpyvdQOdSbz4dn
JUFZEm44BQm2y+P6FJDnDOtqioHvs9lGwd3x8zesXByWou4AQ7XG10lz8p3qRyfljeTBhTbo2rXn
/PcPcwtJG0LyfIqPHITwrUUJMlREYBrKdvv5x68Mz5KlO7U27mxZxkdU2PasiX8CEIL+hup/xdpc
Eu9aGSG+uLiLBtIHWdy3J2+s7wMWRACkXhihlevz0guFuQWusSjyn2AhPN0YuGii2GMP/iX1yrVP
X1zPuwIV8bnm8mjr4pfn/WVKPH0+8mtzu7iTs4GUBKRUFArRgan6PIJiHeyoLyV6KxO75LwmpPAC
nCxYlZo+qHY+8KzYxe30TuvkwrV2ZWyWdFeTjk4/srg5Od13nj375c/PR2btuYtkvJpk0QYsbU51
Mz9A9+jV7ZLHzx+9Nirnv38IqGFM0TgqY5SXqdjCDh7evFdS39bjdCGeVmZ1yWrtKiW8WWFMcE3O
g+fC39tLTcK1YTn//cO3G2gpctfi0dL7WzZPXnwBobQ2JovorHBGtYmTm9PoP6EgsAM2FZYd8Z6b
L+6QS68THPCOgz5Kc+qRtIdDBSvkPr8EyRT/abn/I7la2lKYvoFgfjPFV108ODsv0cmr1VVw6OmY
70Y3UdsWVKQt52kFwVmepw95BR9t4/nwKuaxl467RpbAAMPL7d7JdbsTrHLvwNDy34gy+p2Kor1R
qZs9zzWEWOHvgDvXYNObAhbxtxCHqLa8nuY9BeDvOHiG3mQ+6vMQVSWAFc9lWQMh0w/un6ly6m2f
O3+LbJx+1kVQbzrVZBq8kWCs4OHMWIpLdtA+E9HDHzxvYISHe1bQ+8h3dXmFHuZ41TXU01ENKsFt
mnp5EFn0jjFtgsSwboQveDn7Zg94W7oLZsYe4SvchG3XDdA8g+R7WDI6OKFD6LRxLLPbJFNhq4mz
ceAeuO+FY28FFJ1+zlTb6ym2+c4XzRS5wzzApDmxEM1zBPQ14AqhbmRez2/GR2aXBV0NY+yhKA7p
0I79vnM4/aF7d4ZuS+3Ync4apCAyg0leXOv21o+T+DadMrnPJzd/nJOp37hBp5xQ+nl60yJWE/T+
CnHjc21+jCaAumWn/UOecrNJeOP+nNG9/MVhA7xzU99F3czq5wk3zo07J3IDa296RFpNf7nUyU8S
th8vkCOrNo1JhNriIst2Om008thuTKatix7xzjpxEmm/nqJ0qv5kyIHfp3FA5g5nz8dCkPrAU8ki
4njZG5pTWeQZx39NJzo+MdtmHYygMgmCbYZ7tT/UVwJ/DcsSTZq86DnQVIn/xOOqx0Unqw9BaZMy
HF0nkJuiYek7PL3k+fwNvjdeexbXqUUGjvhQDrcsBsFWK9mGBrzFELC5+hbNsvjQuxVQLhOU9jc2
5iiM6tjQEz4zd08i4cgXB+UU0Gep/LHc+omayNYEqjzh4DRHwbl9sDbpt7Or5p3KTdOEYHMbgFEl
a988iJqiYNAZ+c1HSA0hXEHUq7SluPOlOfdWuP6Rz0T+7Uic/5pQsbxDGTAvQs/36hfRlPbZLUhN
IyLjGbQ/Goi7cfAZEp7e1LA0j9tbVEfaY8/PK2Dm5cmrqbzvK0E2QWtFNOR1vtPKd7fcZMbA0YNO
oVeNzq4tp/pAhrjZlCzXR1qwUiH5tGhj4+p3NIHj7Zhrsl1pDIk4srQNriIctYnGHHy/664HxPVW
uLZBVsXtnsdzvi1kk+0gN39OMpTZllOHhFz13nXp1UiifTLujTX6YBooDE8cCk0hUd13T7O0QrpX
uhvoPjVgXUGp9CGfEmA+/bl7OKcV99ip5qOaXPROu5wC3m7nGitXqiIKdFfeT8AEPArAvIYQAzDt
AzeDhXaaBM2V7r1xZ+O5vSndVl8hIwyeU+T+O9gP299gooE8nqd92I5AixfWdnoztHX9kgY+/6HL
gW0GgMZuCtS/t55fcKTbXQKfBNvEmPLC0uahCKYkDRWlbRt6TmcO8BKYNhbaQNtODNNB+SwIG8aK
o2r0HDHZOQ9NH2g/QiId7FXnz++w6NKHscDIx1Sz76YYi5+Jgw1DY8PbK0nmJ5XG8SsBFvpqcFMD
cLHk8JMEcuQ6A6L7wRvldJvBsvo+rbJho4gUBwvx72NMML1NLpK7gqTDQVSdC+W8yTkQv5RbahPx
M4CXYjgPc/euVTrDGo+SJJybRkRJ3GUHv6rhft2S6sWZ43FjemryqKyC5Fhgt97VjEKi1SuxysmI
7JU5U7GtbRnvoGiQvhRQ69nN0KLaUN9SDSnyZsTVUNShVgFSS1RsG5LyaAA28gB0hYmKTj4Hbg+1
Kic5b+gkOxDWAqrkM3kfVGJsw1mgchWWgW52hgfTyWW5vTcDSKpIrqdbqYW6ySWxxYYBvrAbGTWo
tIgUgBGCaRkTdg14nn6OY6JhBaqx+0GDbSOkl70w0kFuRCTq5AdOeQPuRPJQjFm2K0oj233rVcU3
p3W7IeIIvqMDu/BNw7TZx2Nhfzki61G3Y21EG+Od/efj3VwhBLyiVJEugHct2xS0R1DB9phd6Ao5
GQkpfH8idHa7SGc69kIKTeurvoVueugXjdpDCrdHpXP0X/MB+0mWn8v5JZNTmMPD87pK5PBtrIXF
DQoYoqZyRDRZkUTVFNTfakbGrQu/zyhIHLEfBRDJRTypa9cHT6SLq+GxzqAAndiZHoAI6Tak7pCP
+10WJaXXHqE6ok8O+P/4Gi+YttCsY7u4kHOkVOLn54qqu2sK00VDNurjmFoaNZMf70fpqXCqsLdA
Uean24rkB6ON3cIegm/xH+MwC6Q8to00WFcm2HC/h3Qb7lJ3BFiJGvVMx/xOdTkeusTwV5w/3iku
azqH7oBdZIcOx7Pr2GabxKQGFdDmdgSgI9X3IFvZXVXl5hpV9nLjxwNktBun6d4RH+x7G6A+O4+u
2XhsqB+bsfWugKmZd5J4HCFspo2M6fSI9skhLVO9x21pwMpp2DVil90XkxS/OtT5NhUSzq2vqvqA
guNwJzVtDnkc06ikKcCsUxtcDZ037UwB34+0drwoVp1zi4upexgYmTeite1dE9RwZ8lz56lRXvPS
Za5+6W1XHjtZ36dao5Jatd0GR0O2J6xsz8d6f51DR3JnsSQPZ2QDqsIxZL5iHOuGZS1E45vgzeQ4
ADYitcU1YH7yphsElP1J3u/s5HS/hxZlNJzt2b1yPQ4uh0FpDbXz1wbmd+8KRb+wliioTY0r4TKg
6IMg3H3wc1Xdi9HL/4AEARfgQAenDsBXrpp8Wycs21cB1LaTyXOfKGQuf8e00k+DLfieqJHancFO
cyszSAl32rWhZG7/3k+B99fvA++IH2y3sKmpr9I8Zo8oFsi9nKfpBVARZy+sx34PvJzeCt6626Az
0AvqhjJs3dq7iedO/CrjTt3woZxfEhRjEzTWyuEpH5LsvR7K7i+OecjDS/Te3nNYgz4MmfDRpR4b
71Eo4qfhCLkBGrYqQelQzlbBtUTVmm5ZVqgxPAPCUDiCWPoBB3aLupfLytsUufptZ5S8hSlbfz0p
5m2rhjsvjXWdu1GTsQnnwk9RCgQPcFMALnas5qDfMKJTPxStCAAws4596XxdYa1X9ZVqgHRLWz7c
o2kBxneNK9g+cwiKntp7deHlEJVW6H0AVP1ephU8X1rtPpSD1TclJOr3raY4ufKKXsdF0WyaMkhu
M29ChwQ4hj0cqfm98mL1kljNytAKM2yhU8G30jjDBoczfR8YAIJh40swP1AoPsAySt6PHaEb5TkM
5XpbTVuMn/wdp7n/hLq1Pbdjui0Xnnud9ypIQ4HbMbwTJPkeZB2EtPToRlJ63lXQCvdq0F3qYfKm
aetBlfhOZaQwgJ0EFr2V2N2A9VBuHJezRw44rN16KKffZbCzgqUwITsOT5Ft1rX9topZclelPLt1
hJPt5rz3fzsgHIQoZVsRYnNgd8Q4G+a4OiwyP7/3ceG8HZCW/wG7QoP4mQJ7zmzSXfEJtWLBG/De
49rYmwRXvQdt4xYoNEc9tI70GPyz6IQ9vqu3dJj21Kdi7wEfuadsah5QrmDPXm6cSCs+b3NW9/vJ
oKlkm8IbwpQDOShdyEf3tWX3ELsnEQw6xeNEM7hMTgnN+IZVMv8KToyQpYaLVxoU+GOvPqVwBmqn
7+gNhlhMn1cJVpL4pXALHV0C/wBan0QM6d/qWJrfQ35BFWYl26bef2fxLQrAk2Px7A7rEFt/RH0Y
4G36TkWff/xKmWCp1FJVHoTf4fl5mrhzDFKIc9p+87VHL0pWjakJi+GGfcKugGMfGciFWtjKNy91
WOa5BXHZUfFREOfYz/ylLrILxaSVAuFSaiVroN5YWhYcFfw8bSe+wWTpGr0CWCxN9LmJ8ws/YWXN
LAVVApYPU6pTA8VouEoMaKOcab27zwd+ZdEs5VRQn4X0a+rLY4ab5ugB5QRrwyqIZvIlzinBreC/
l+VUDdUEl1t5TErkj5Sm8Hk2dyMZLnmH/ZtqjTcsyle9I5RjBvQpujgsIMVoVJRuihfx5kcdkjW4
eV0oS64N1qKeBSaM9G1bNifdHvOuDuEZtOMOtiNYhn1tOhYxnDl6DAI/MaeAY5uGSgSSlhCc9VBd
MlFeW7XLsnMbjGXQoGIGsDQED2hyLDNzyCvSb8gILgAIIJeK82sLdxHURaGoX4/APeQDkE8QzC+r
SF2yQ1l5+FIcBdaGJJ8IyvNN/FQydIl5GybmErJ97ekLVAhpAfF3nTPWlncbJ/smWBdOziU9qpVN
aalwUqUmd3Tl4kIf9FsHl/TWvySq/B+9ln+ULJc6IyWJcUdHvfEqNy1KKCh2z5vUKoj+pe7AfwRG
i1eIVo41WHamuJ27Em6dvp6uDKUi24IQVITa81rcaUfnty3QxE+BXwMVDGiLtB0vCe+txNJSswRm
rVC00T09dvOt26sow+YwAV8hLikwrE3hIlgbDzKIkxe4x9iq4jpR0FuoHWZ/NBkcTL4UrUvbqSLx
YPnRV/w4VySqxqvSP7NBKFKQC3eRtUFaBGtMuNfWlnpH303CQP3W8j6ZwJl1LnR41xbiIkJ1DmOz
HqTho/FRysgpKOdNceF4XBn/pTCJn6UVUpHeO+bpY1uB8SHvpraMPh/5lQ9fCpIMbUt9ZxQzNq/h
oSidB4ZK19cevegRFcWcwO8GlbRkDL7NujxqVVzY3de++jzNH/ostKf+aOvOOyJvhsmKj6Kacd8/
/+y14T7//cOz2yYIBp94yAn7MRxamN61WDWXVHVXFuJSVWSAWgayfCwUVPBBbt3UKFVkw1MZX5rQ
tc9fRGvKhqy1vesdUSoIQXkMtfvWigtjs3LmLS2eqEyAqIl7dsS1HrIMbIIXYTE8S8GOFS//GuVM
X1w8i4BNUJ2YWODORxm/A+MRxcWly/faDCxCdfYz1Asl945A13Y7tIyKg0R6dOcOyEKLLIbJ7v//
QvIl/vnvhTTPk5LOlLogDAUykg4KeNRNv/vOV/TZzi9YnK3ZyMui9hrviH5pZINnMd9Cb+XC1/9r
mM4PX0Rvn9R+XwvjHds6MgLYtPJ73oiwqb5ih3V+wSKGk0T7AUp2E6DCJZS0Zwg7xHyHu+0LfHIv
QXf/FQ3nlyyCuSqLAnUqBHMSFFEn59Apf8v5ktz9v8Lh/PTz9vRhq0Atd84bjVOFlK9Tg4LWocx3
3KtCdJC+OA2LcO60YwMSS+9YDBQ9UnhhmXRn+l9IUC9E2tqP8P77RzCUK5pAZt4x7nB/Sp5lntyl
+m8OaafGZ5fOx7WJWMQzHMD7wbAWPTBH4W7MBnqUMmuOKfWbF1UW3kNa5DYIJ19BcjWux62Tp+i3
lSWqOajDAxqmlN/fQyptvAYBxr2qVMqARQzayJxbWSGCgQH6NugZ2DDotyO6mw34KEnU1319rdsW
nr39COOb0imr23yAYExQcf6IMrbY+uMwRRo02FdccHrUM6ca+PFGpd0Vs0ptPE92PHRHrz8CIztg
hCpYPPlp0ENqgaEe2xfswKu0exVeHF9Ik9amZrFVuWngNWi7emjkKAAn1a4vu9DO43eoKoUGDLwv
bVRLJQeXBh2jkwvRW3NoUJ3NwWwAjPTCCv7XWY0gWco4oNbnDVMz1xAhw0fTcmcr8YVrwPnRiz2K
ztYGKGE3pzx5DDisMPpfXxuRxd7UZZmKBSgFp1T9MAnqd+iUduzb1x6+2JOaYkyT3geWLmYk9LJs
W/vPgl+SF14JtKU0zwClI/TU9XzshpNj5cbpX9M5237+6f/U7DyP+GI7gl7ylIGaHVzBD6fUUZ7B
FEOQAu1Yf4ATA5Q6TrKQKByrADebKIhNsy3coYg8SJXe9rKTuzqdmk3Lna/4Tp0/abF/NRSY+yYf
yXFO5h9aQaMGbsx7Bz3iCwt4bUQXW5cHhDetGLZgxxPbNnsC82dTt38+H9G16FiGOCdxUp2va4Vf
HhpK33lb//3So5eyFBRUL9/LWu8oAVCJ03u3vzQiKx+9VKQIkrJjzoARiYmFYJKPy1Np5YXzaOXi
sZSj6IegHRRcYY+eD8k9x32hLdvnQT5A/6C98I6VKV1SNntDRMkABzr2Hgvb/AYsiNCqS1S4lW17
ydeEkAzQuBUjx6n5CVWmbe39ig38E3DMONmFyV0bpfPUfLh65ECGpwGQRMfAfzLBD9XK7WxMxLP+
AuRs7UcsIj2GQy8YMR4/nz3NOweR7JCVhMSwDahRa8lV76LX49ufny/WtRlZRHE3123QdTk5UiZO
RPGtqqCdrN4+f/ragl2EsOsAsR8UGkkRG8KS/3DZhQevffYifM8aJl0XtJB3tuAso+Ny4q29T41D
9p9/+coLluRN6niJzYqKHLNgOMxZD43dJLjL3K9IrWH3XNI2eT5Dx6ma7TEZqpsBt6mwcelT1SKZ
o/lPX3hfu8os2ZtlJ5RMU8REN9l2m9b6xs9huDIZGqbSOQp9qXmzNmDngPkQGFOfD/AMcebj3E3J
WWgv3klH+luui6/IJp7H7PzqD69I8wpKgnGXnCo9Hh2ffYNiy49MfIUJeH78IrQhd+sWPE3Goxrq
IwpvGzDPXgBEvrD3/aeNtSxsnp+/iGx0kSuSNzE2PwbiTNI6wy4DXnGbdx0YHlA/gCTFrG3+7p81
aJAV1y8ubsdbINYSiHy2GXzuR9Fv6lnJOkoHKHQUANcfbFVKuVEsyYClArvtximSCfhLJ0W3onC6
O0UZ+VYGXvoKs7r5T5L11Y72w/gA5rB35C5wSrlXD1BD9QC4m4dp/P15EK3sZUsEvRk1cKUxbY6B
mXSYFt2NyoN7LrtdPg7Q/04vvOeceP9jZJcg+s6jfgqQSXO0lfMWF4D2DOYqtfq+KGQkavt9ZP6F
WVzZ0ZageoAhAbypYwOSm7cBIQoqb3r+8/lwrT17uVuOtsGmwM1Rzv0h7wMSdu78FX9qrL6lq9RU
wFjBzSE2AHrflsbtD6vHHcnYl1oCrrvkiHYVyYCttd0JREL/dw51o0etm0tI5n8NTYCnL3aXunDQ
/kw6eyo4+U79YuvGX2qX49GLXaWCKDCForV7QnXqjg7ZfeJP92JILmTg/9oXz19+/kUfNq1CQgut
nEAurVsXqTRgUeB9pfefr5h/3UbOD19sKR00M5VBvx9Qqdu8fas1cJX+rzz79bXHLy4HEHGb23Ju
u5PPOiecJrMvgcEKRYNGUisvFTfX5nax7OHyO9JphlbICPqY1sEuY5eEcNfGZ3FNoEJBj3bGosQm
5G26YPC2INyMEZeAJGoGaPjnA/WvjQ7zsGSUGBpncpyle6qqdJ+ovtmOrNZh0EI3dlY1Nonmkvjo
yk/6H2aJ5yoXqDwoq+Cm+Edh3wtBOxsPstcE5LC83Xz+k1ZmZemehjOF+UnWQQyNdTcAexzmwHv9
/NErIbF0T6toEyBFQsTltK8OCqjmKzBK5xs09b6SzJwnZBnURsWJO09YUwHZOWy2YWLtr7bNn70G
spCf/461ITr//UNo2zbF2iokOcVmIrdcE3ZIAO/74gQsgk/CO3ro8xKM4EbEx5apdpvR5FIJde3b
F0EHPmQdsLHvTxIErobx6x5Vv8+HZS0YFkFX6SbXYwPVMOtBNs43h6T0IyDEgc6FZ6p7oXi2EgdL
ZmQOxYBgMBpAAzf/Q7STXTkVsPqxpGGXVc6FKV5ZqkuKJBS94hJmnVhHQL27iSjDwZ3thucgo3w+
Wv+6u2Cl/g9FUlPoVEN65NTWWdire6ABPE2vQG6OcrCxx9K5IECyNmDnv39YrXAqzuZSU3Ki3feq
7aHrfTvzN57IC4nr2g9ZhFwK9ShkZZxAt9+Dc1PuNEBuuQeeBNfDmZ5Sy2EEjv2SJsnKAl6i3PLO
qbQYpTlVbn7NXBH6ZfLw+ZSsTfriVO1nNk4NSFmnzsLes79lNgVF/QuZ63m+F2HNSxDeS4rNLxmv
HZZtJClC328urKa1T1+EdRmMlmYlP/Nr5gMYd0+4UKKoHHyl9XX++kVsD9NUYKPw3BPrvMibmqdO
pfse6vifj/zKpC7BblVKAYmp+g5AqOat597jUMGY7/Nnr2xLS7QbamezoJBYONVBBqjzGzQXD376
VLZT5DT8wktWxn8JdRNMpMXY4MY0Of5zqYQbunX+1GGhXtiQ1kZoEcWctaRXTTudsr64o7LY1zV/
/3yA1h69COAiDyZdJAapZ1e82ji/9lJ9oQqx9ujz3z/sPQA6UcdwHMcaggYEgvLCdNvPv3plW/uP
FOqHR9dDGtd+O3WnDHoUkCPILL1isx5R1J30NmBKXjhw1qZ2EbgB8N8ShHNyKkAUjPq07cLcFRSs
PkIuTO7aKxbRK/hsgxmErZOCrXjmQhM4av1q8/lA/Rtl6LpL3y9ozjY59ObcUwH2euKU4I+BbZDw
/lts6WHK2V8ghSO/G7ZuN/8E9OKaXyQXr718iXZrnTxogUnD6VP3aVTGcPEIm5hgc/JhXB7mE1gN
jYcZkyR3sT4EShoWeiS7uCqHe8nj9vXzYVhZikubsNgmYFlO0OCNqw46ZuwaqvQXLAfWHn3eeT4s
xYHWpA8MNsdR0AE+OTW5h3yr98WnLyK/KivInvZQmGD+dz68etOfzwdkZdEt8XY1+AG+rPFc4dfX
gUsONq9P+O7t549fuRYsYXKJYqKNJ1z7JvHdm0jYQPy1TPId8dAqlirq2/3nL1r7HYtTu87FWBeN
JSeU7u77grIQpaMcSiTVpY7XylazRMu5ypM6pUWHjipkXBxD6p1J+nzDNYCoRWuSr+00/xEr/rCO
AndIEzHCFyMP6A8LNhOhxWuqL6yjtV+xPMIdg8O1xxnbog8agRPrPFWCwtbdz/K9dJPka0fhEj5X
Cc2lbBBoNJ8NSllZ72zmusqPfFbkwk1t5UxfouiIIPBJnLF2tZtCf1Ifux5tK4gaN78q+cVEbOnm
BXZqeza46XDTnEDDI+oN7dRL6m1rv2AR1aC2glHYt/TEJvVOasjQSe/KU3aXJP5ugs/El4KDnIPm
w5IayKxYCjjLCRa4f8UMAbQKNWKnnNSFo2vFSttdAuwKza2dQUI6DXnT/2GsNBtZKrUFryfeNw1t
r8Dh9jcyceLnGPaIUBXX5B3GVGA6Bm0BBrqku89/7Mo+vLT5EopVGcOeA41e89LBMCOc/UuGIyu7
zBKJJ1MjYg7K2Ek5Hg8zbt6gR5ngPlNdqBeuffziDiBFpWmbjPj4GZpI6Tx8m0j39/OBWVtsi9Dn
ytcFJTU/9d5bXQvw9/iGkquCz0ddvH7+jn8PEFmi7/ggCMBfg3dykkcFCTlI7oU9vTA456hYFvpx
FC2Rd6SBFYnLOyxjEdz5hXpMSvkuJHmeRX5hjNa+/zx2HyLFqbqAVDympyqGiQjziuwOruQGhLFx
vrBrrf2K898/vCIVfsWLSbATNGdCA3LYVEPJorZR9hVk0XmcFuEeSJb2LHbZiUF6EhgqsCV7HSdb
oD/+j7MzW46Th7bwE1ElEAi4hR7sxvMQ27mhkt8JiEEMQhLw9Gf1ucrhmKbKdymnChpJe0vaw7fG
b21SZFmDl2eTJzOw85MuS2HkWeQbP2bDN5++2MxDChRSxes6yVvSId9XoH+/qGb94jWs1Bs+a22q
Fyd63gENnoeBmzjibgRXZPhg4c/LVvC1FZOlLtHcjxDxtXOZ+F4p4skOrJOjGrERavnajslSmYh7
3OpcBW8OR37DM/2nIRJtpPl7K73Pxp73lz9iZZ0u69NcaEr2NsWF0DBx5eLsGVUK6AWAUkEydsvD
995yPjj+Yw1BafncCfspyZriORuLJxCN76gcHqfN3PTahyxsGgdxpE9ZjTPo8ERwBm3He8J+cP3n
8hesTEewsOfAhRpY0XR2go2n30/o40+Bt4D3Hmj9AU6A/SaBmX69/LKVRRuc//7PcHFfMRvczy6R
DCIcU1u3VwCVvXQ1Wrouv2Fl7S4r2TJCS567CH9VxrvKRx9iTcPGwg3xI7/w38syNmG8os9KOic2
pCoj8EnBbe+cWyHEDaLcPz0MYxRCJShSAfquL3/O2uwsrFzMQK8wNIgn+JT8MQjZeOyRYM+vVeAP
P0Va1BbAKqX4e/l1X993yFJayZPV6AzuNEM0V/NfHnp4DllRkwMoAFYaMwTP4rnwUpy8R8m2biZr
i2KxsUMRzLKDzNFJ7u5TUYImcu2pLQNdefiyns2aZ3CHaIprTwbWZ2MAXrDy/KUdpo3I9NoLFh7A
kiiDDnudnpSWtyMhv7ugOigQ6zdWwMqCXla22a4NdgXabU7SkMcmg45CkdnqeHm+1378wvh9ZHcl
hiQ82davcbib+x9Sfm8TXNazUZnyftKzdXLrOwNwLJtAw2Mbh5C1330erH/8SNs6NmTSwE+cwodm
Qj2JfJLoO708KGsjvti+lYP2jmHm1qkg7XNdMxSmBPNWCYbjnE33CzeyVB/AVV+kSJoU5wM+aBC1
0c1fxuvwqWQZKeO5D4oq8ot6uIKUEI1VU7xRXcz/SRzVY3ug3rVLpNmlig3XaNzuTlnRePuCT80v
iZ4UpGvnwkl8x55lLAbQSlJpGQDEKj7HM2tDMFpzJe9q2ZU7JLecX+ftJU6HwiRVl0qQqZW6dwHR
QaRAsBDw5zH8qUQL2d3QLULIOlpWHesgBUtn5MoLYujBvnfh6IH34w/ji0Qv/K0sZS1jLgfJd2OY
W3+YVXpA0ECY8L5PLdQRNA6qgvaoZBpeHGgbITkVlN5/RVGkBB40R59kAT0JI8UYeyPxE9z3ujc3
s9RPUzDgXHQp2I5yHZ1Rsdd+KlAUVqTOSQ+qh1YsQc8baAsvpO3/Vm7W3OY5/FZg5/n0WPFSpDsS
Zu1vFBGNUVWQLhrq2sWrygCk42AcHhnP+oOTtuIpncYZ/z38lmyU4AwbaCSiKvlUkhx+pdDkIQhg
l0g5eP+5HvOOAl7hjjPmHRxoS+wzIE12uVc61wOUmeKWjm2sGcBU/uT4h1lS937KXP2XWEhI3FY9
PKtANauOauF1hxrMmMjVQv0EzEG89RbAz4XtIoOh6BiDs1zuRpLXu9Fwitrpjt86k5NDAWs0wMDV
0uzLNHf5ddAq7V7lbd7WsWVlYMoUjix/knLSTw0KYD6My8m4d6XnVwfbscI6VugZv8FddL6e9RnK
CyIte+t4OMsIRX7F1axzCl1cGAeA4xT9zF4JcISb2cFudBvzLkyJuEnm+c0edSq6iitJ7SOTAUB6
rAie+pEDaDKqSkYKecMrQKuB1Kg1qyAXyqywhVYv+A9AnDfzNdWmcve+7eVJB1DTwS+KGOpL7tXA
e7CW4AZwTSD6tQLR2uz83BGHymvSR2hvjNeh8lSOk36PKhBW9XsIxYpDWjYA35kuQP9o3w7pKSgr
9hexfusjhDbuj6YoYTi5aOiwl7Rvr2kKlnfDPfagwewBTK0WzW0xd7a/R1Px/B5IQSJ/7s0P5HTd
cgc+mdvHpu/FsG+oO4PMY3kH3DkAOko961pIUv1IyzF4Dc64bsfW7mFIgQIIumZ6zBpLXvUtKxAB
UDpRvi/2dUv4j7pBejKAxNk72KvWlRLC2gdF/YLghX09tSEQX4Hn6p9dBiCzT0KxQ18KugZkSU5k
rosHjh656miHvsc2fOaKQ15WnLKC0xGuAAxLVCtgLspd4IckBrpmf9kpr71gsc2ywG0548OQZL7/
kQW6gBTg5EVut5Xl+bp12/5/UiGOm0Fk2vGD0wz6SpQ/mB/TL6eLulvIHjxaP5334N28DI/DbXrn
Pl3+qJWj/VIlJO9Y4+Y8CE52N4OKL4MU9UnlbBVRz8DcEvmc7S6/aWX4lvFMsCjl5GVUJQ23x13q
o6qndqpPYW0F4lcOqks5ZLSnlkVoHOuEtu9oYAMU9hhKDJ+AMI9IOx++9Rn+4qhYkbIdBmOGpAbU
6qBFKl8KgMNt9GRvyaB9NSc+dp9FCMvy09JnxqIn3v1mqsSW5iN8Uu0yZ6vS/6u5OL9h8RGz1ijw
mXv3VBczehjdtr8rPU4OovL1hjl+NRt4xbK+REuiCeqL6UkMZcL9OyiOO+gpgN5M1KdXl+di7R0L
i0wzZhlUStMTwO7IRqHfDV5XVOXTxICkbDT66rS2tkrBVwZtWWkyzH3jDYHdJH3bnBR0HULNbi0j
Nz5mZdbp+e//HCgrB3yqkgCTghRYF6dVmN3MkITaY66m49Q01caBe+0958/75z3IqbM2G9D8qbo5
RB1z+jIF1oPMLX5DAJL63swsTsesZg6DKgE9mcyboB+QX0PX5pMM/lGZ7s0v+sPl96zNyeKgzCqF
Iq8ZTZlZq/44xInrsvhltPz1vccv7r6T1brolWygPAAaf5BPiBfccvvz8sO/OuSfLWRh5lC9L9HQ
M4qEjPpUNvmVlaXf8LXnRy/suzNh2XgEw4/j4YeVkSn2y/kjlcb+3guWhSaBznFOLyXS0Rp80vZp
OGfzt/LAK5O6rDRhIW1Y4dExsbM7Bxxg8BsPFYQ4Lw/7itNYlphAOCUvprlpEvCW1ZUzQRkamNTm
xi6li8N8WB0CpD+28jor1rbEKxUqJyWk6LGlh+ZTOs6NU5Q8wtd9+OncblzQ116yMGnqKC47f+yT
lItDO5EwylmV4Dz3nzf4G5fpldW6ZCyhy6kbpJZNAqrHnV3qF8HtbyTXsFqXJShVID2vAc/yxHMW
ASAclTWBAPLz5fn+Unzr/PilETt2RYStSWJBPqpjTnlyXXXMAvIJ7nLcV/bJn9U+DaffUyX2l1+6
NiML2w55WWTQtpiTwvttHGcHTG7UF9WV471efsGX+cLzVy1M3KmGsnInuHFrhsQCquSzK8gcdS9Q
RFB36Drsn8Vs2SewkemxCxl5GcXsgLPgkB/EEtWDGonYiD+dt9tlOAE/ZVmbAqBuL+eaAr+V4/YK
+RTOTGR6E4GefWunfyDDe/mjV0Z1WXviV7xwBKqUTlTPAk3ubM+gc5tO5g3HyeF7xmSf/cY/+2OW
Zl4+QtIYuXCO4z2xWHgPBV7v6EtgcgdmoT3/8ues+Dn7/Jn/vAl0cCfgY0sgZ+0Y9Kro3USzD2cz
Wrz2/PPf/3k+giDS6Yhtn9A4BSAtZM4+hQDrNhN9/d/lT1jxCsvqlAFyT5NSgp76pvvsIfnVkvDp
8qO/inWfV9Via7d6YBMQKEDpdjviRm8gzOiQGET8e39IH+0mgHCQ/kN1+XD5fSv7wrI6hdV0QkwM
gedcv/kMiGo1IqZwL2kLePvb996xcAueqCxAGsrwZPwJ4TMPImc8cthfjvpGgF0Pl9+yNu8L12B8
ryGCj/apcOdrKxNVhNPdGwDpwcYW+mUAEXOzvMuN1OvG2nhQfBtHYu/y1kDeSjriNU/zuY0nYblI
3ijV7gTtgOgvRX6vcps+jFD1LCO/6QHK9Trv1ABsmISp8J5DxKp6QCJK8dP3VXmfhWlVxAz6glfC
D3mipjbbYsSsrNplrYVxhFV7eiCnwi5uq3zY0bLfsOm1Ry9WLfoL0XxFNJrXJ6bueWkXB5kXfMPT
rj19sZUFxWAbKDpCqxA6AQjl+eYOqI10wwJW3OuyGsit27aXBN0+DRjIwVQbsMyy2yy3XyhUqTbW
ztonLNxriviakQMoEkGlhrspdxng+MXWDrGy9MnCpZbTaMtgBAJVOeF1FqQvAhSSbFavly3rfzeB
L7a6ZR1QD31LywEWH/0kDbnqqjrfcYBzDrbw/9p9xg9W2dqHsleQqSvQhpCL1r1yx9SCZkb3Wbo8
3WVhWYDcpPtHL2zpSwNc9obH/Hof9paJR1I2JfpF+/HUtBrViBmHWEP3Uo/uYwA4cAH1hR3CoXxj
n1wb6oUvC8/KYNKfmqSR9GYo2KdBKrXx22+U2Z1dzMKJdRPXVus55IRL8U0GTlH4g5kaapT2t34/
aun+7+5oZ00HlvVMTwHYO7+A+xcnCYjriSLG+z0Kkrest9FcVUobI5PaumFF80jsGyB/jiBUbVjT
15uWt6RdZZJX3KkY2uCn6UqxZz/wY06CmCIa72t9vLzsv3YM3hJ5peQsUK6VOSeOhipc92xkGg1Y
4ZU++f20sTd+vZ68Zc2Nx+lMDJK6ySz1g6TyiKjxQdRbWdiv/Q7Ee//vdDuBMgGf1XTS2sMxvEwk
ag0uD8/aJCx8vgjmPA9tCWkR6INLZJCQXmhQmKT/oEqpipUbbLiflX3XCxf+fwKtu9Y8axLn5/A+
HtjpMF6ro52kOD7+Zi/uM7vPHshNmjhXz9Vt/rpFOl6bm4Wty1lZehJ4r1W/dGEXlwHEFbfUfddm
ZmHp3PHH0kdHVYJa4I/SeB+2tQUVXHn0sgJHhX4mMooQSw/Wy8z4U8C+icnzlnyokoNGYOdTm8hC
1fvctv9WcwvAv682ltWK1S0pUUVP8qCwanPyhgrA55TOT6Qsp52YZvqWTWza8CFr71nsmVpPfmPx
voM6cZmEFVD0UEMHzP4gcmsjeLCyfpZFN6SmtUOmAvPQy9it6x89bV+KAhCbyxa4si97y8KYcAyh
RYcMcRK4+j11C+At/nqQ6OLpfNfV485yoHfM1MlA+QlFJJB8DbzYt3Q0ELRsUCgg8zIGdO1w+fes
rbuFnWbg8o9Ql2uTrDSnntFjOo8bq2JtKBemaFdyoE2IEw40xO6FVz+QzNo7nP66/MvXHr8wxszN
jCvVrBIxiCL2bfo61XMD9sTWUlhxlstqmBJ90c6Y1rD26Z7pGwRVr0KaQmMrhyDOd3JNfugtQU+o
aoAGc1O3ySTUpyBh0tH5fhqqrcrHlfldVsRoqCXbDvLCyVh0B1r1aNfcKkVaCVd5S8ZTg6j53M29
SvqC/Qe/mACB8JpR2seDKvfdMD3SbHjphX1o6k0ZvZVpX5bKQO9Au21N6iSYGyS4s5tJ1lfM3TrM
rY3X+e//RCKKIoOYMS50SQsF1iH0VWyF6juU8fNkL7ZfPVI6m2lQyVS8CZT4MP8/R28Y8tdBCG9Z
KZOVJfQyGDa+sjXIwE1Vy39jqycxC2f7P+kO+T0xzLzSTgNZB1Xfjfd+2e91/qiFmWsbhKN87tuk
KyUUPu75cAfVE0SPUVxD7AMy+Xe8rU4NggZDc2+n34vlecv05oS6QogItRDeHGUR5WnUdvFc6T0U
baJ2hvSwub7saFb8wDJdz/2AVvksmkSOPnnNIFO/055F/xO1BE67yKzYFt0WO2hleS9pUXOKOBhV
fpvMJnEFj1k2AC7xnZQw5mrJiOocRNWm89OH8a1wmzhDtC3cPOKft+H/f+X0lhl61bY1xF6wtWF7
9n5ZYDyf9VbZX0hwFTtnrvONCVkbo/Pf/7HRyiHMGdHamBgnBNJWRJ7ioE+lG/e5FRewpENx3UKs
p+MimS15TYbxUFJnI3+w9uiFA6AZOL/o+kAPDMJMWjQf2ucbtbwr9s8WG3mJUgWWV/CLiht2MHOw
Iw6LcFWxb7IZ8nTat47jHHr7wA+2KIVrE7EwfS9Fct5wREjsyqIRmdVfyVGPpzR1No5La0tqscmn
9TQIB4LrSTPUMPDmUPm3wxicUrTjXrbulW/wzuP5z2KiRc5oMNkmaZ2nLsyiNLxCd+7Gw1fiHN75
7/883JubAMoS6HmyxM9Rgsrrqdh1rbjoX33HOwbOhkWsrKslkklVQDr2VYj3eHY89dV1wOhGIO9/
E6VfWPUSyASxpZEMEJhMQlcNO2WTIg5zStHGZaMdCsXwNEoLOd76nU+vQPxKD2OVuW/QfxsAlQSC
pXFqNNPJrI6EXTt/qyJFBZs5a7hwd3pOeUY/wBmgj5OohhvozikAEWuxB+oLciW8hLiIwRHf6LGI
u7CsXhGElQ+XJ39tfhaeRDaejy6/RiVpWU2QtM0PnSfj1DUfvmSJV9p+hOj09w6sSz6UnimvxwlY
DJws4z4FCn24qoutpu+VXWoJiELHN+Qw0lwl5Mz17JMOiRoo/uyy6rZtnI0L2No6WziZCfo1yhJ4
ySA/hvzQ8q0yn7Vfv/Ak/tCrAhg8BRXtmJI/XqhQilFFDuJ0Wzvr2m9fuJIsdIHfNtwkRQixmi4g
Pwa51T+z8vOXVCg+13Y72hNOwgqarGYsisiGwhk0SGcdQTrythT85fKS/cojouFriUbsrYp0ck6D
kwn0yQqKl7wYf05FCu2KZuuS+pVPPL/jPIT/uK2htSlSIE5w4sV10byL6s+8GehYe/ZiCySAa4ID
gIY1redrh+X7kaWHPrB23xuexQodu07kPtNTYpnsd0vQdgLdSwoAQfEutb/hbr9MaZ8HaLFccYzn
gwd15ATdBcUuHSGX2PSvdtO84WqflNV4zwrzQunURxbxDJSP84cC1XgRhxbe5Q/9asmdf8JiOYf5
KDvwY6sERVj8mFul2lWVL+4Hr7V2eejbR3sIvpOGwsuWm6TyeTf1An0VhRXo29lDdfz54zaW9HlZ
LXeY89MXu2TNciGUoqjatT+0fBbdn8tDtPbc89D9s4zVnNWWHKr0NLjMuesYdMLGkJuNi8/KQl7u
izpMi86acAoNQjiSKEVTTiSVld7Obj09f+8Lzu/+5wsspHrTwM3GBFzB5nrQrT5aM+s/v/f087j9
+3QgkzvHxipmyhseQqnVtYZO4jefvjD0wZom4QgnPbkaBBBe6zvA67bEx9YGf2HmAdJFkJn1y6Qe
g3yHuhJ2PWfE7ObAm74RCTyvyoWNV9ykprDa9OTkeRxyH2HkaZe1G8f1FfNdQjo9t2OCKFYm4+yE
ERXoTqjz3I/mVvzOZrQkQIHn6vI0r4zVcnMy5UTDKR+xQwTHOWTwSDO0vfWGL1x7+sJ4oTFKK7uu
EI9t29hMxxa8YeG3G799ZbdbsglJGUzwvoVC+OpnQObIKX8r1Jyq8PHy2Ky4iCWgcMauPeo+NAkf
y26HfFL1mloozN04/6/9/IX90mnw3Ql501PRibgYZFR294gpRu6Wka2N/sKEO4cjIdmq9FSb4sMR
4bXf+y9unv353vAsbLjF2IBeHKYn2pvsRnUErbRduHHPXvvtCxsG4yZ0ehw+EtGRk8+sX7xyTwiq
fKegEQa8LE6H/HtTziOa6nj45qsEmyXE4pNWZ8fLg7NiwsvSdGgQ+36Z5eGprarmfOi7A54yCgcS
Ox3fW431cvk9K2t0WZ+uxIi2aZ+iMBPF4nHaeM4jGZytnNbKLCy5h50lMi2EUQmOELtK613R/mH1
++WfvrL+l4XoaGssHb+QbgI8fESGzzFs0KjxXm7e3s9e5oujw7IUfcg8VoQWfBtau3isGxk+CcZ1
rAVNLfSNZcMDevegsu2ecwOXP2ptPs4j+c+2qSFa35Ydmlg7bzqGbvtA2vR77miJOlSBA5oyKErg
dLI5ln0AMUO1BaJf+90LY27yEkKgKU71VhncTqp9d1S+sZutPXphyp3KhTtDQzlputC56S2OC27W
bIn0rC3R5U7cGkiwQuLulKH3jXggaAjIeeutpuEVO16WoKMHrCuHfAhOTtv817I/Y43KebQu2jXQ
Xv73oFXojvi/q8Zi6KQrFd7S9Ta24eJZtOY4d2zDma5Y2rISvXAUGUl4NgTr2cn4Tp07UAEa0WZj
itdecB69f1Z9VnvC7sD6P/H+twX62aF1raQw1p2s561r9MpEL0vQsy6TufEw0URDHHcmV5K8taaO
L9vt2tMXdot2x9GF1BCe7lkRan+DLgTNZ+PhKxawLDqvbYleRA3jAsGki6ZK/oYQ4Z/LP/y8RL5w
csuq8xRZYmQ6dHBCn2UX2SGLgw6IDnSLXWuaQtwovUmpQHit+2af/rIQ3aBfkviBcJMxU7tgwvld
enTHArFxef0yC4692VmYtG/aElLuekyKxpqP/RzgdsN59yqK2d6hFblE2k3IwyBx7PDQf/mK6y4w
gmFeHyvHDne9Z0DcdCdpX0EK1OxVhbQ5ghbp1uFhbT4X12snGK3U9h03YaL59CHAVCLKaQefl2d0
ZSku69CrTpZp2jThKTdBbI8/uX635o09d+3Z563yH0PlY0rDhvgjwKQQZB5F+Ju1ftJgDL/32xeO
oNKU01biOOKD7jlMP8r2pRw2gs0rrnhZZ671WJfNhPOmM6sIMJLDiCRPB6Xaqd13W92XK1O7xCCC
4WcKnqU41IbqtSQkIU254STXfv/5lf+MPS2Hvs5GNzxZ0nrT4fTXcWqfRFNvqxtbpeUeFPctsfIV
h7ysOkeDut1WpnWTrMgfnEFc9RlLLL++LzY7I9desdjWbfiBMSsIdkaVQrmQI8mKJANE+gAiSrm3
u7yg1uZj4QvQPO/lpseH2AzdU2N9hBTGxq649uiFFff27APjiHxRD6XNaOwh0yZs+fvy714xtGUR
chjYvgTpGju6znYIEJz8mqFBa4vstTL4SxihBQJ8bzNU+adT9WDlVpyiC1Z0zR3ZesPKal2WIDfE
ob2ALGGSoh2iSBXdFcbdzUCtRzUV7W7UrruxPdrB/+aYv9jFlgXJYtYebed2TkTeO6gDSr0XimD2
tUm79ug0Vf9X6qx/h/3kr2qSwbGmPAc2gLXdQQCZ8Cag6LGvgJcQUUB66+coSo5i5TF/6mRBf2h0
h4PvZYYrPkGLTbIgu2Eo34n9vgoSyCJmt53rsmsKHv6OQPD5rqy96cEZe37E9ip2hEA2JWJhkx2a
Yar3QWXbf7oyrPeOM4FpUfYNSqJb9aHQij7F2uK4staqfHGYRk+vxvUMhR0sjbyRqocUPVz/CcL9
4XDuXN/lbm9OQ5+7B792+F8Tes2PbrBQuwZR+zdI+ukHUF/Gk+wG77qk+fxo2T5UEgYyztdGc4tH
vMnINalSc19CVOpcb5F+hpbMDmGZZ7t2yPN3dMHL373lkxvOAs3jtjRFeQBnUIOkYFfJWDG6Iy3y
nMwi42OlrfRtbkb7t4W7PtgXA3/y0e/eRkWW1/FMvTqPOq5wouEhkJgtKSkAIwz0E0u2d+2Y13tc
T505ggVP6oQPh/SrN9ukQRU3hwyVa1DwmQorab2JPNdewzHEQerd+HKwT9oPK0i5esGLcpuC7v22
yVgsedcfIILoH2BhlTgQ4PEfG9eZ6D736SB2rgNkiJ1KJ4iBwygjr5z1KyPN/GygWLJD142N5ZB1
B+irqUPRSfQaNjNK7bpGXzcez04j53qP7gqxd+tm2E3jgDLR3AGmRA/6ymnnDoqzTX+NYlxnX4+D
9wim8vCOC5oaMAq1czX5QQ9pZmmucB5h0dBQKSIs2PBxJHJ8CqnrY904Fgp9wvQoxsA5ACwtdhl6
RI9Qj/diFMgGEZ/m8dML8v6mBjTmB9NBdUv6utthG+nux8Gf3tMGwo+6R/bANlQfcgoQomYguIS4
u982nQj2OvCA3R+6+g86z8xDF4zeDtuNuunxuoM7opgfXbBiR2mKa0Hj6nsQsdTBKUHM7aRunm0G
ZL+fdZCbdhHdv81kE7xlo90cvL7kD/Vo9fdN7tggSdM0FuXY7ehkVTGkGcL9QO3hh6un5iBS0+0F
Cao9tNox6ETpvZ/jKQY51TjDTNzOhNo3TNrmoNwwwNRN7OCiCXRPieghhOCldx3yT1Hu2hXETHMH
HQhl+9PtZRC5VStuOBdo2QEx58br3eBxNim/tdt0jKWb++8EqfyY2BZ5NE7d76qaAPLTakYfx7Zy
rljj21dkxMosbT3f1RoBiTFj+e8ZYJZjWLnp0QqcYd9Td/hh0+kDCHl67fUzpPgmCWLyMLmRQ+bx
1gpAWomoDTQKYA7VlZ+O7nswqHmPFrbCjhoLJW/QMXLvWhyg42LqOOrQJ4/tUBr7FxUsdVLJPvx0
woJFGbSaYzeERMOh5qH+gU6fH2iC4tDlzQ6eN5RX3oROqUhbxvtRZCb7nMusibmoxulUMSbR5e9Z
sWvZDWjF5fyM2l7WxmFo0oOpafUAAd32qVTlp8VQcUZyv3nqGlWfhtmnb6ZkhMeVVkCcQ3V339Uh
vfO9CngY2pE96DfZB8W/Tjhx+PB2hfajSUD+hMy2FVXQ2dllTfNh6tK6lqSYfzQE1ddZo5vYH6v8
A9AcTWNkFvJf4Qi0wpUsdHmXOeDDiCmDZnDbV80zZHir6zAwdlTbpnpxDcKwewPZ1mM1eiZx2CR/
UTUOVcyhCHHHVAXgsOuHf7w+t1D/Vdh7wF3wvShzi2Rdj7HRpRePvsUOXAn7CrlfuqOMOElAe4TA
izqFMjwUEQ/jDJmPg5f62ZHXVQtB+qH0+7jyc45yDZkfq5QV96lfQ+lE9hhIO7X3Tsta8IbQtDhB
QDAeDO2wfMP8PnO94HmerfbZqHp6tbsmOBLwvW6CYBx3EDSEKh+KI49eMFYdVMtTjTIdyd/mIic7
hqrT4yxnNzJS6mSYGvE66zaIgh6/vkIxZ8zgdKKZht4rzWj3VE/NsOcdGX5nwkJowZRQiqv6/HEQ
INL1TqOOfWthJ81nonb9bIbIs5W1p0Eh35mhkC1tB/eYmcrspO/quLTQwZ4RVd8iWTscTN7nN1Ot
9WfXNuIugOM/8CaoflZzBuqlKtwiRu6F3lqubV3rgjZXWBZYIYFXX9eZUx0MSGz7uiMs9nqjoHwH
v91hmobYM3VwgDoyeW3q2kCsoQ28R1WyYIqLsLU+JeIat12Ylvee6c4wpHMxoamzHxXUJt85qYpT
G7blbc4MOwZDQHdmTLuTsvEAM3c1/HevHtBiLE+5fW5dbLD3vvgWRQUKS93Hs7BtVEunep5INhdx
phWR+7DLU6jooS2xQYwadKayPNK6Lt4qw8A2GT0AwiYmHyrlszg0lIKtrTRKCub2KDvevgpQtw9h
0JY/3Kn4Twqgcnfa96cbt8Fc+Z3WLzhMwORTm/PriRpz7QIX5UIZUpZhbGcKuDD06ITzE8VN6wPo
Bdbvq4qzOHfapxmtSxUPIwET1xXcYknbaJzcNLj20pza914t0m7v6H48FCE6kkKf9CentmBavaiv
qJ926LLteQOY+chZdiuBcetjZVGtD+ir41ekg4JWHPbYfWclmjTKS1I/k9q2d+XogidWVPZzU6Is
XowUV4Ma8QjaiTHSwqusvTWl7HFubLKH2yK7zDbmLwlku4dSw9jdT7pBTtxAzxF4NySpvbD/DGav
Q9VmXY4fdmCPYODZOXWxsxUh2fU4/7x31gCdxNCrQzRUO/VBKa1ijdVSRyMkwYvYntzsg6XYAGhr
/+0qMj9PWoQoY0hVoKK+JNSJjfFA4PJ7r426ogkOVlqNsQo8c0tdSx3hCsHbagJ9rRuLxeDAuW3U
6HBQsd1a2YdnhWUiHJdA+LIzGhX6fhN5OKhZu5pRuMTJ969z9IUegUia73XQhK+uDy0JhKpBeq6U
icGuJ59gapXQWeugGqY7gLC0lva+lKw8ziMnXRygHyDftRzXgEi7QNVFvLfGBy/j+jB2EEMCgBsp
pSAX+5LN5f9wdmVNburc9hdRhUBieGWw3bbbPSfpvFCdoRkkMUpI8Ovv8veU4xt3V+XtVE6CMUbS
3muvYbNA5bHXMuCwJ/NLfhdEVXcA+69+pjM86RIYGzsn3yk7ixlUg+3eV473IjsZvmuHNW9urHH8
hiud9vWKermRmGkTdxC7WYUeisuovbehEduCefp5nIPxQTY4QITlfuYNdA0TOQS8RINYrVGiBnd9
Nq2EBRz8vIRIBKy0g70sYVs5YL29TINssnJsPA8MzkXeRYFb+FkbSA9uzzTAVhQI4+fFKp2vXrsW
Y9rWnf9ehrAU9e04nMDqwCwNmaC5CYWGmx5pZDoEAmH2sh2KdzosU9qDZvVdK0kTYa3JWxr6Tyry
7ImrwquSclkpLNfKvvg1uaHDdrDNBp+DeiY2D2DAqDZFcobaOMGwa/qBHlYvLAEc0nraRkXJD07Q
BjYNLHc3aw1CXGI9z95PcmZZadDNBtG4ZmbSsAeM52VNG7OSIW19iWLG2rp9cnVZ57C3Ge5Wa0Kd
qBVWbInsqX0wUq2boD1DWk68NufS3sF/jnCbddZpxBpweU6mCUUTRMobMQ4ASoSxcJYZBr4fccbK
lA8aO1xtVRukNCi6R1G48FEcDe64Q51201IXHWbNy5syHApEq2g0ObMqbgakW88Qzjluboknbybb
2HxgbXuLNLp6j8dLUqtispmZ7EGBIc1ptF2x1RNy7SdSw8Y5pO5wHAnhqY2V3FXx6N8yVKTfTdAh
tjNanHHjyLp7GKLYy6dSB8eG4bwA52G5DxG7ct/6ow6SsdcMcv3G3EWuXscUfO9lVw914GKWDQNE
J6iGF3ftfahAnDIfcOy+OEIFt9TvRZkMXTdsm5izjV9rKIUVSpCkBVMjHT3WbIu2cvdUzGJraDw+
QqTSfV9RZO+6FWz6OZgFMq5gYZGBuCgY8kv40GW8W6uU9a55LdkYfht6+EPC3rFrkpKaqgW1EZ1d
5xP3EJci/MlNC3J8I/iUVgI+cqjtqmNUj2XuSG3O9CTSx2m9KvwBn8oXN1jlcUW66284E7qbmhfD
VoBktqVWeBnsBmjGVvxIgD6re9uotckNLN43tef0N37Q1VvYQrBjvEiBdSM85AvoEo0nHERKlw11
Ch/Z7qWa+PDDOg19lVHN3nD/oFiKqPeQCQRzTYc4Dqz6PPl15KU7Jx4Ag83QDTrz3DbeUc7Ut6An
9MYZ+vUZ/kBZvK6LSfQ4Qe+Nto7Y4maqZPvY+aiTskk2NShxtTvHqecUfVYFzbIZKn+FvSQn55vq
EPyOFm9OTBX3clfjJLhroyl6cMchPoCOYaJNGZXdcQzNlKulCE06qhLR38Zp6tdO6Ihvh7lDF1Ob
Hl2XP0LyP8Dno/ZhkAEbRXTw8ZzGYe2icNXyi4AfzVskUZHm3sJZeFf3Uo5PHnjr1WuFSVaVN2ia
69SVw/oFVAHvILvG24VrPCTxiH2+HWHDgZ/dAjl5CrqoyK32WN5DpF5nXdySm8IjyktA+8ZSJoPp
f2Ba0CZeq9U38E9pBuNHeoNKbOpT37TDczM3qkyYswwsCTFzeYFpIquyUjMfeEgXkz1cNeF0WK1r
sJtmiR2hRDu6UXHx04MtAcJwmzFBuGngZdYp4dY+1MLSrCx2Gv1Bew8jU9OnK43CFgabw2DyuKuR
Clj0vE4doFq/C9ObjdFdjMJ2ke02blaRIElQJpGvppewgJy8i6Fc953V/CijaN4iaoenMx7ioxcv
7vMggiJTivrYhAK/PbSAfxKNnG3kXwfFdDMr1Z4WHjT5yFu+AVHL+ablbPcxarS9gN/oMTQhFUnr
du7GmKjJtFT1zkSO3IYD47fdTAC2AEpf4UVJ6Zb6kNQsMXKpUW0nwIAwKCy79STQG2W+QQGYCPga
76izSLyN6Is4CFutvJWxhD9LKcat45g5qVRQb4qgtrdWL2aHFzhMyTp3eVwweduLtkQrEMbbiY5z
EqKTfR0EaVDLLXzjgQh6X5hQ4fddG4gtV2SulGiVvJibp5CDRu1TDaF9oZe04CqCbriL7sa48G60
VxQVDGlpkfmNsnkvQ7WHuYFQqJZV/LYwLNNk6HV07B3Q1NtR69s1AglqUHP9DL7p+obyUXxrnHlO
ZYsjPIM+jqA+mYU9gaPfrqjAAWPUOgjuJNfN0dHTeOwwOMQJDfxos6IxfdDtpH/HBkbTyKtDymzd
Ggf+dOisM6eLXZUiGAO78oAWaQrh+4aNGB6g4rYgM8CvtoGIEVHgm3AYPHjI1jIv4K8H2AdMBsx2
OD0Y6/rZXMbzhjVRAJzRh91RG2rM+xqDRsV25Tc3kvUDVlOZIJ+vPoZIvc66lVHUmovOvXNbloBf
JmwC4kKRodn09hPyfSvMxcZuTn3ula+oodwctLlwPy122MeN7W5Hp7W7oR17yJSoeQghF98OzPOg
vK36I/e5/AGv23ijFzfaEj+gMjGNLbaAEsMba1sv8V1hXsniL9swKAxPsG81Jx2v7qEhZHoMqom9
VJyTTJTSr1LNXbpHIeje9M6M+w/nYTtLIK2jswRHQOsewtkXlkbogHDgu3pXDKGxSdNUYdqWmO7h
pEDGrOyd4FdsG5ycRStxsHnd6CHLYCDRzsgi2sneRjkCGOc4L1QPb9GxjOCkIELeReeuTs0pOuQ4
r7S1kM6Cnx8Js9zGA5jWCzPr+zTSaguJODlFJQJmk9Dz5uOIlMTHFnFXsCGzGL5zp0BNWjjGHgR6
pDadYOL9Hcgf/U1asG4BpsGNt2A+u4MBBdgGZoIrJGMhSAEz8Izvvpjrp7knit3zvp+9jBHoYtI+
MPo9jETzDFwsvLXlRE0WeXV7x1VoN7VYm7t2rQjcant2PxMP/gFI3H0vdcwfowHeKPAyxhSUgJKR
R3M05pyKIXeN4SmMxtyj7/URItS9YdMJ6YG83qEVIhbunkE8RF+LqR5hsN909wU20jwCYWSnp778
JRoa7rtpjk5rYe0W0pPhxm+H9tnTQ4R6AjOXb14FzFSib8/hwezvVMDHbT/X7hHZ3haJClUAeUGM
aXOE4/jdoV7BErFADZSBwu3dFzaSO1fXqNiWFh184tIKNrVSwlO1bGCOVY2gEsMPWGwpHuqtRWia
Tqq2gtqm66PyNDpxBafSetqgIvReh7Yv5qycYh893ACeQdOvj6svBZxgmY9xLnIQva3vNnWxDcaZ
/4xQQ+0jIUMKL9JoOfYrQLF0MgGkRAy82cbK9a2zI0dWqQrGLawJvC+FsX2+ak+brNdTlAZY9Y+z
han/bFr3zW2rJTvfTuqs2GqKAba6ce15Oxir8NvCBHPmkCb+xZXz7rrjvJkrtbz0iomNE8Mlu50X
73UcWH/n93b5rv0GyGwUT/k0V/1LhyIjbyV8DNyqy3CIZciMic0uWgyETnCWprvZdN6XYAhgSN2W
uodJMHeBxyr4PCcksADlGSYCL+G5NiudUuxRJERQmwiRGag+N4ppaPsCtHaLrbs6Qa+9PutKxQl3
mPvDndcYTqFEPLR6HI+ALhC0t8zRBq1YvNMF6rO+BqDOcY5tO6mjnCAvZ1+hyzMp+Dd0yyrZbeeV
/FjDInzsHBHh9MO34SXQOjtJ/ovNXXVUwNMOHFvLszvWTqpLGeDYK/Sps8hemjAITOJVoRLo+swE
aIPWNprTKgDkSpqwf8XItrl1fGzXvi1t6g9LePBgTgaJLq/fWkGALWCmcdtziX2eg1KFX7Du4CGJ
kcqUAi9u87moUajEwn/ExlBsVgQ6oHb121t4dTFUvagDnzynBEkNhdO24+16I4zLUrRi6DxsM6HE
Bg7uL4W3rbViTyUIABmqDhyreqnzqnBsmSgnjFMMQIYTHKjl95VD2enBDDxdYiFTj64oiErDc98i
M9Hrz/D9YL/GJAT1OnY5rrzIr7arprtF9uQZedNf59FBas1Yll+N8t6t60CLNMySZfB1HjIkSLEM
Q/h3f2nNL+WVAOSsgVWyiHXODa+WnIbYeRIA7jCDX6kLpDcOp00k4ujb2sn1uV8qWaaNZhyNnN/E
SRPENq/8oE6Q3BJCj4rtMgwBQ8Ple72ZuWPhEjO4j7RcsPyV4o8cJpVwT3ejG1hP1TmOsfbWVVFx
V49j9wpv8hVR4367HRGll1Jdi2zucRIOM3SuElVJm6wo3jchCYNNtQD6Q8HJTxZlYJzBXQekwSJ0
cjr68abnnpfOnY13/qDdDJVolIeBBhFD0kgm4+J/Y7WxuVi7+MjpKvNgLfTDaMYWeV8dB8jilLt+
UPEJrIgp15B7ZxzRWxnKVb0t1IADfC5DlRRFtH5BTchOQcPJu7Y8Btoa2MSsbEEkSBm3qesOS1oy
86Mq0b8lnRLshVTuE7WRmPKx5fo9duCVDkuGYQP78/6kPCD2TdD0X+lShXukyS85GyKZBdN0fr3Q
ncB1qsxqyaN0dF2TIICkTSGlrb+LAH9v8QTd8MqFTaoZlb6Jl6Lb+gWGTw7wpNe6pu6udKp5g6k0
GqVy7KtjYRhWIXDQpIqgVgkj9Yo9CEBB0cWZlL16Fjxmmxlgxa6kAXuAQsfHFwkxd+GOT+CQvQAh
3VpMAc7bdm8t2CSu9xOEPPLNmQpyByNzsu0cjySFnsN9tWJQU8vQP3gN8GhMjxCy5iHEyy6YdDaV
+SaCfs1Q6eCqc8c3rQO/8omb/sbzwjCFiN3ZInLNZPFcq9Q6ncwKGekd3D+GzLaACJIFdfhj5PR8
6+qqOFjTGaQPrO2+42glWWPim4KuqKRVw58R8vcDI5g2N8hGyGNFS8DwQEwdU7vQlc74WW3Dx4Si
sjrhDYWLEwqRG8jQOZQ+wbIvdGUREtGt2aLQn8qi0XiL6Xw/lu28RX0B38mwpEMGx3fRZKisIKTq
x2pXjLWCyQcGru1dC3Z5mJRDhHgBQP/p0JqFJJq14Z5EMOKx5VwzjC0ndg8icV0hU6Fj4Gia6VcP
oP+O+c04P1UAWMukjjzvzi4zFqZb9f2GctK+EbrQQ8QVuYNtZb2fwiAKUqM5JlV1o8ISqLYjcAfQ
oEqAwIOoE0tmzM56DTSzKluZMkmkn3SoT3LeM/ItimcE3suVqmTEYbRpzeploTAADCvsiHNR9MHG
afvpzRscsQGVvslqO4usR3n41UwrA9FpiJu32m+7OXfcXvq5RY/9E4KWbs1F5c6HuPHqfeAHwfce
Fnb7MmztT4UR15QEZRvchmNJ7uMKRSWQSnLrTR3F+1w1CRr927qGd1o8d8PtPOFfJxEGZyxrsUeO
GcXA+wDX9XLbKiJk7pfttPOnCdUOZlTNzejwJq8nXt3Yvl+/T9UCL0LRjkNuOmLeZhGar7YK7MkM
Jd04IvC2mEwFsBDsm9tBzONJ+kYegtqjT0RQx81abXQeSjQRWO5qO7RTfBSNXB7squKcwT1qS7oq
gFpikAAsp4ojFEKhP8fuBIi291D/C3kCglfloVgo+lnXL9NKq/lNOwjJAETHXQBjFusipm3xnU69
nyPCp9yGflNvmiBSD5KwOe+Al6ShXso9APT2wbUlSTVSjDYlwvCewrK0zyEiuLcuiZrb/mdEHP0M
Dr4NkmryRqgUer/vTnqyWicNXr+UItGgSQywyG9sKfDq6JAfQ4+HuN0FziLEW4684ejeXD2ykxvM
/Q+MvRG64fle8IpCR9EEkSf+nCkvVFXalBxQx+SM4ghInDVHV1Ud+EarxgCZmvmhGgZgBgHzg9xw
wkVeF7PeBcpHYLKvzbKLqC2/FQNzNkWPOI/NbGAAZj2sm4S0pP2OFCP93gq3XkElY8VX9D48AyuI
3LBwqCDpGWUOY2KOfmilC4bOVNm0j6LzZB4hEoyiIUIZau+KGHef0LIeErY06200sfVXXTlO2vHZ
yWcC4V7auo2944u3PhLXVt+jqF23a7RaD66aVqQL4lbgyVjW+jRAgHdY/Oo1guPX1sZM/NZ64ntA
TPrF0z5LlY9ArlR14YuvmPnW1y3ej6Wb3g3W3UuPGb+/HVyudghcKRA2wcO7GKkgt5KOoL6oaXp3
rcshdhP9xqlxf6CicCcBTn9WvxnBymQaTOijT18EQZcq19OI1FhsOjgFM12Dr7OFLr5C/gcPUZQV
ruvmjEmkfPi+7J9jjXI60QifcfM6HlqWs8pVm2rCACVeQ5UrdH17vUAAlvDGiX+FVSCfhILUI4GL
9fC4IjB5Qgu+9FHaUu0k57yWnSJwVevgRHovOUMjLAEB/IRPJbzQ1KJd8OiGKV/QQWDQ68x+myD2
ptAAsMIYtA+CI7JvJAZeYOjEKZCs8mGFtfhNPfvLUWEU8cqjiD2HAxW3KJrUowgXsRsWDsfZFmMK
mFWEAHdGb6si9NMGv899C+F3jnNdpBHzy4dhKcx9aMwtzBB+V1NLTgNjQzbyGZNwQfh2RKeSuAuV
ue3wlkI8znnG/Jq8Gwz5b5DmN96tOBgzxpXcAg7uEKJq4sNSr2iyo4DlDsKlksBnE3CdoHvHamvu
iYzNZiiYuffMWt8A0gnvPQw/UmiPq2wYOmAH3qiAkWtb5JgYLbulhlLBoCn9QqNA3DE3oieklpEj
xjwVMhBHTLQ0HtswryYbF9AgJr+djuPk0QffL+k7eutu18tRTWClGHdLNZKeEt8rvAdDvGZznkHP
4HVwaGA99CCYiIbAbQsMaIitRe46eDcbBQQKaYj9LekAh+sKmE4GXWCxwzvdHLpgLDeDz6CoF1zg
ODN6REnfhmPh5WWVTPBSvq3GFhbBGn3xPsRAD/MlnLrzAMycVr49YfyhE1Oq5tVF9WrSmQn5o0VU
2iKKfouUuCDvGrxBHzPnrlHbLmiSPOSDCKNzSp8EdUa2LtuAZHBsHBuhdSz+jah6GQ5LZeHLCsyN
QwDYUELAhB4BoL3gzx9/i2v8vwt25DgR9JvxsBxq5ERViSOjDgwqL3qv+BLnH3/GFQKje8GNXFaw
v7oZcW8zRzf0gB334+teUzBfmlaipeAksgirHBq1bxRHG9pU6XlAWos+a+phbxsfANC89UEWI1Vw
M4JT5/SfcCf/+r1wWl6oIeJygmMQYqP3lXwZw6ceZO6Pv9hffxRc+IL9LMsIXRv0OQcqMDEZEu38
gs/4Jxf/63uLi19Qn4GRcThbQRKqFijWyJg6jGPdPpnwE/7ztbs/f/Af/OHewcFgyro8zAtHS7mD
Fw3gy+gfb//8qX9cHXbOAexsBnFYMemjpVdk6Eo3LMBs3HVb9gnV89pDuljcS0zW3i2r8gCuI2qd
k+v3u2I6Jyivn2wf114e/7/fo4xHqvGjmgP3+rSkv5ANl3389ly7svffKwN3rYiaVbx3G7ntfJ67
dnz5+NJ/Varh3blYyZ2nQIMq4eY5z8MJ7MPfU0lZMlqJVtgb43SJ5q/OWn62Dq79ChfMZ9JPmOMV
qzoE5JWV9x5B8lzz2I3OJ7/ylSd16Vep0JXETjDSAyYc6rYcuhiuT9FnLp7Xrn6xivVoOhABB6hp
5mbPdXQnAGh9/Dtcu/TFGragotWYZsUIp4+KpOlzpw0/C+y4snwv42EXtLh29cGX7yKQTIhvdoir
07nL5f3HN3/tAy5WsFAzQD3MxA8wkDwhzm9OIQz9Xbv09ePr/1VphNDt80P7Y4cY45bZYrISnPOl
ykzR+Xeley4pgoj421D0+kFjjvDQrX10u3am/ZcogwgffLGkg5JM8wojJsy7NJSinnMyKDxSbs59
MB3JJz/+Xy0Lz59zscCnEpUYjaGXBsF1W4GM4onhDoQ61JT2h4UNI6Hsqej0biBrnX38UP/n5fj/
mO/40IulX/qk9RxftIc4tP7JIbG4W8DrWzNA/4BlorLPKzBfkByjWTKTuM6YF1abSTVFYmDeiOQ+
S3fNiDhWwYpmM/c1DNuNz7aYdNMZ/bcFpaACgpQ4od+/A7xvEtaIsdlVarIVCETLeuupHuGYolO7
PibjqV4je0tWy++nuvC3VJHpiOgU+1RPNbqKUQkK4KTVuarxEue4Xflca+3BYdNEcBCzfYvCoMNg
+uiGzfJARxGnLLblprBBsI2LCLGTGM+BexSNdf2l8IcX0K+dreTE/ymBru0w7xTbfhz1jabhmWkc
ebDpH9fDXARrNvhmQb5m452WWIu8cSZ/K8vSz/lKG9CDVozXY4dhqmqUvV0K8K2r6VxFChHcNwGd
N90AY1VgZypE77bwbstt2GxCtvhHEE7dzw6NK4vy0ohwBlbnYRQDUzIQVAAPkkLffBqPfmW7ujQf
lP58tqhCyRGiSIees4Qj7Mev5ZW1fuk0yBbmrE1DkafXj/d9MemMFc7zOpdT6qKSHVSXK9rcEJC5
P/7Aa1/lYudlvKkR9ITSLIQpwsZKaM6h+PA+KQqu/ArRxYEXVX6DkZAT730MqBExmgfsEbvwJw/r
yr1fesHObjlHA0z19hHA5ptYgro1zDTYffxkrtz7pQnsqBcRjQxnUjRrBHdhpgdYPAbO+G+Xv3jw
jtP3oYuw+AN4v/frakFndlWyeP8UMOzGlz6wMyl9DP1x+2Rp07YoMtGd6ib8ZPu89nDOf/7HmeRO
wOUbjRVQYBBOdlMdYjj1me8Y8c8nzF825/D8i/9x+YKvbiO8rtiv/cBSQLf6zszLJsY8/xC2ckbG
MA3A+XH8TMX0Zy17+cNI/H1HCzTtZvFf6Fj5ma3O2F4MnWUOvl+5aWuEgEzgAL0IjbGt64jxiCEa
WJ8tHLEfkBwG7kpQh3eYBk5bWimyLYjqM9+tlpvSrUBPbMYaLDScgc9uWUQbNGL2YXTVW0VkrUFf
ms29oAjQjjotXuOgNntgwwXQ944+2Rj7WxfF/gaDLfTzoNnfhdioynRSVhxoVEcgz7khjljdJtyf
K/iU8XWrHdjTFisB694pl1w1xNkHM4gJgE1jwMGWvgHCm9+YFO0e1oznOGbVgQihgm9VTYKXyVHm
zrpqPQWyXM8DAMaBl4t1A5M/8ULGXp0M4uogrZcaIiFiv2oR+t/mmHQnZ9EYT4Av2xyXuGZ7pIVR
wDE1eStaMb1GlK5tVowuSenqtVtYcLHHECPPPWjE46O3zvRWrgHY+EvkIevVdPUumGb7ZQic6OjG
jGBSxkEr9Qi4LVhgNSA8CpZ4z5qcN4uAvAVprHXv2qQGP+sZ8rbgoPRAQF/HMDCxjmVJVXuQXgQW
EIsu2l+QCjhPfkP6w+TV9LvD1PCDVIXdwLJpPtZwFkyQrOseaTOBJATZ0w0kK4D5CChMY0Ve6sJh
YC1EtDoK5FSkQHmHxNcDf3Z6xGkrxAC7n2wEf+/6XQTV/Pdlh9pKjmQiKH6ZZfC11uoFDLXqeYWD
FbhpY0t3LsbYd/WK1pm2g8ogOwIUB4nJLS8oAo/Lev0XfyXsGhclXzErCms2E+8n5zgv+uTGzrFD
stTHe96V/ufSDhlW8agmYzfeB/oNkoQUmdEJvOml+XTn8K5sHBdVnQjAVwfQE+2tsfsAfUUiJQZZ
o/8OmdKcrJ6dElDSmsSf1BP8IL7auFFpHX5m3PL385ux8339sXEtAvRAkKT1gURgY/k2nu/isllz
zKh9vMJ0W4EIlSMLI87UaL98/Fj/fg6yS1MsDBMCzyBe+GB68n2S5S8CWsDHl/77Ps8uHbFwWRSz
K9Q5nu5+QLVlH+K+k/eBXrrtx59w5eYvjbDCQoe9qCvvUMUtaKpOeIe07uePr30+S///McLoRcfa
kpWM7hKRg3EgCkCBasDjTVxMLUDJGO/wf/6pBWSXjlglGfxS4sMOlpA6C4KY472WYHqUU//JL3Ht
OV3sEipch4gEjjkoVr+EGEyNhf3Hx3RxmMdLrQr4OdgDbX+tdkig9oicLtXTbQkF48c/xZUXiZ6/
1h8Lo1ethsOqSw6hzxRsXPopnSc5wGBi+CdfL5fRi70rdOBcG/f4iMoJwl3UY/aY+YXodqRrF3B4
JlF9smVf+zIXq3xyB5B/IklhdFeEXyARKLcFhUEQdDbl14+f15WmGCO5/z4w5oHBIJaOHGrjljcu
wTYlKzp/5SVftkMMZjpgMO+Gj7S8sfysC3Ym+Qni8Pd9ml2aaBXgVUGpiFoLA653zmZk6kBWKUj1
WHfkE7D7ytq8NNBCch1mqGNN0H+zYDt2xZJPo6qyGeSBfA6r8SuJnOr3J0/z7+cCuzTUwmwYeU0x
xCIqMuyJBarfr2QpH8GEnfbwyocicAxel3isD9CEQNQJGRlSRMEgCR9E1S32396cS++tSPDSaVak
zDNnznC4ZqyCYMh8ssiuPdOLPYIrJceBzOQg/HfHgQ4L9YOngLcHbyDT5B8/yytHnH9eFH+sZNEo
l2u/QLxu29zDpcm5gTVi6sE5m3k0lyPYkPX8amXR/lMTyS79t5pgWoZy1OQQYVfKmxYI4VwMMmk6
rf/xIy62DgnFI8CPeT1Ey65pH+bifi2fPn5c136Ti71ibTUL196xh1kHecjNBiyRzFPd2xS0kO5g
uvrx51xZs/7FfkGYjSiKcvcwtXuQaJNlslt3aTEA/fbxB1zZ9C4duSDRXfDulhDNVc6TW1SZdMTr
JIJP3t0rZTC79OIquaJOtK7I3gNdKEOm7rLzJbScowLpSLqiT10IEQ/+7PlHZMdhcohqrzkxJJJP
STz13XZoKvpvL8Slc5dZDF2rgAAWgXtMAvVUDiQDxj1d/29nrnd+Xf5YRXrxZOAELj80AnixhZ86
nTaTF3zRsj0ZZ5o+eS2ulA2X7l3Kb0UJigg2nBlyD+2LTDW2yj5+Ja68c97FVmBmDUzdKdZD36OF
bWHg1U/g2C5wl/+X6BeI9y8tvGJewjW5gxxuAsVFw1b2zCj6+O6vrMxLB68BIG4Y1dw9GK1zBncA
Nb/g1M0tdIB188mHXFk1l6ZddIAasfNhGDMuQ2r8DRiGif/ZW0rOm8hfCtxLx67aH/hEhwlBqms5
7jVkSFVaDSMoC8FcxwcHJN4NqBFh7tRMbNsVvNo4AuPHqBCUZQg3PnkRrn3LC5wPjTGDYWXlHrr+
S+yLFG56zj9OjzHC+u9ScanTVA2sYQ4T98CFEQmhz0x9Ynp25SW4zIS2HIJ5yGhx54avOeuDLrVa
QrPZMmivkQu2B1Hus9j7v68X6Fr/+00MJNaISaqWQ3TWUJmphivvOetTVUgEapb2n9Y8vWyz47qG
GhLOdwiNn11QV2mV6Jh+Urdd+an/Zx73x8Y1Ng04mIbhqCQcddqrCiCaAAn34zV57eoXFcwUOSD/
RyguGli8BHG7xXDjBlYvn7yn/4P//7JgLm3GVMn7hSlY5VQhc36bURew+BhRi6aljwp0oGb5zsCa
FJtpJfWmimREM4+W1WHyLWhuvh4D+KOoim0MRgr7XkErRxy4r6VhgZwlOJouiW2cVqcRbMAyx84a
PHQ2TSBW1lWmYOVx44HbDRYTDzaQdpBjNejlTXtr8a1ANMFT2PZOEsWde5gFqpzSMfGuaqIIaJRn
MwUhIKgftFu+tq2gyYIHtlsHJ05XeNXUKa9D/QwNxJBDueP96NqoeZr6vt8vTtc//h9nZ9LkJs92
4V9EFRIIwRaw2zY9Jt3pPNlQGcU8ivHXf4esOnoN1OdNL9xVgKRb87mv00k5e/U4R2cD1A7oegyk
/IqM8UNfzPZDz5PZp8itOBEkXnPXyjMHbrCQLnd6jHsuLeuOw8iSFqK4FJyQWCvuWuRGQEQbRtWl
Skfj+5x2XIB6j/xJ5Pf2/f12YFzvOows89uHsLPHQlTlJOdg7mAUkXJwK2KkheHkMEm8vm5ftl+z
PO5afCg9FGqxhrCKjUFrQahc99HkZnn/bfvha2VYRvEPZcijri4TiYenPYbl/NsU/eICUkemH7Zf
sPb1yhoQG7QE1i9YKXcjfbPFWD1XEa6obnq4atodGXAZG+aIBTLt9UNWQ+ZRQWi8s+Ba+XSV25aU
pEViw4h1Stgwd9b1r7i2P29/+d8Z/UqrqtQ20CNEBa5PjZx6jqOZGNlzz4Tk8xdihhi6WDVryInJ
7ZfM4OyADIoRJ64J4H2mMyO5s+EMYkJkC49xYgDLMUJJjtSLJ6nBEr0nmX3qWUkf7B7uZhV3qB87
zGzdGIStnbpfmaVUKNwE8yOryawOdCKBTI7SehdE3s8ZHAlBBru0IuI7IbQyAKtAOM5wBjgaFI41
DgqcOPIRMvvJw5mZv90Yay9YAuBDJ4g65LDW4zQFmehnH9fOSBZvQuu/hEDLftMsYqrud0ifoAJb
fFwfdTXWOl+QuHwHTeBOqF4vgaleLSO1L05GjJ4XJGa6MYlOtX6PzLwb60cZgcBdbAdtiPpAq15N
A6SO8TsS6HcqZmUE0pURSJS0LBuIOS+gqnkjxNKCPfY4nqba3trjeuUwVRvp0LAwZlumQWeCoCQl
9CqfBj2/6U6WqQJJDovnrJ9AdzQxM7LmXoOSbfh5S2CaqvqxHAyCrG+cgrKqP2bMmHzLLKVHTb7z
8dcrHxy1fyM/Jci416A7CXTAJficgpwdgmCQnNhwd1sRluHjQ98SeRO2cwx2ZDd8I9VXzbygF+yE
zvWGNVUTbyJjWPgAExdkHOLpFKwgnklgPYAO2P74tepZXvzh4+VURxPojiaUCHZ3F0P6csTeuDg2
IMHAD5HHOyv+tYIoA9AwjQlWPAMJ+uI/rv9kOvLV9pav18dp01E6b41VFU4zsUrJ4+gb4zQAIPFc
1zhDxMFMVOaH7apaK4LSjS1siUG0mueA0BbKe4eI945bxV2eF8jz3X7HEpX/O2eaqjRyHkhpVS02
RphbTuPcBTjEou7cDdAz0fZk19o3rRt32mTltNt0lA1kS0kCNiapA10j/NuEaRgYcA0pAAfitPVT
BJ6GR5CK7ImBHZAHmh5YN+7NriuRp8p5qA47uRRL7Itu6uEnIErnS81D4162tX6ykyHcGdqXCLtS
paphE/KuqlqfcMqo4RjYBcvnRzrtuV+thIRq14SAtmI4fs+BWZI7icRKd4rSZb2zZz+2UkmqtrSe
kNZtaNiZlfNDKn9pyGLTp8c03BNsrT1fGR2NcghDIzFJABDbN6vP88cqR84NG0f7J7T8ezPgSj2p
ruhEB+sFNO46yJosPWTF1F56aEwCZPDvHZCvvWIp4YeBrGxr5HCBuxeU5a8YcJsaUs0ojg/b/XKt
npa3fnh6EctC6GWO1UcdX8Kev5eDOIrCiA+w5dzTJKwVQR0jUyApzMbml4ZD7UieurZ3S763PFvp
B6qudM5YBEIb8gyQ93kkZvTiTMWP7dq5fjlhqlLSRZoSQcQGsW9k1h5pQCotczg7Cu68CDAvvmVR
lJ9JnlTHtKzrnQ3GWnUp+y5NG4ksQYO5ZEPySJP6KzhxT3pbv20Xaq3JlcGxE60oMKvPQWf5dha9
aHn135AkQOzuDEwr368K6YoGQN/SIjTAifqENDvh3CHnqvGYnG+yANRNVdhYwLvXyZAjfGmr/gwT
oD9dbXsTgD16MezNvivF+Au5/tA1qA568oxTt6DIGUEyM3y2gVhqfZGLvb690hSqVgda4Rkp4hEc
PWp4DwDMu9CpI5wcggm6M/GurCGspXQfSlHWFfRWUC1cCmIetFn3des+nD9nfYlLydftiFqrKaV/
wwkDamWKdwBRcUCq17kQ2XMx2DvT+VoRlGWQLVL4KNhIwgIkWv8EMI91BA0v/gQiZYr03rk+aTlP
37fLsrJQsZTFUKrbfYOUc2QtVcknahtQgRlA4VTzV6vvnIUB8UeWcud8aK1kSk+fxyTTRkfLAicu
woDboGO2nTYd9AgIIFf0VHvLAAW5bbNsWkrPzyXodODXYT0JPKEXE/o49vTNNIxP23V3LQ64AwjC
v7EGfpiZ9iBvBJF95+iAqcBVT+yl4l0b5peHK0HmdBGuu5nsgxjAEKMA2X0neq91wuXBSngZOnBw
UV1mgNZnM84epRDPbRPqf8qZRC+xiLO77epZK4ESWjEWnJDD5RKcw+cUDvOghni3PVmJo6lAegBy
mmRg66fCkG5a7qXDXYvQpXKUkImaeDKBhJGBSD+blX4G8Vj0gyuABOjB7dr+/JW4UVeyuLVOkJNi
9YGUA6AhwMWDhNSTveXHtS6NMrClbB+GQMlmXpa6IQOcFrmUPpDkFUBEsLjAKQaqvkzqnXKsVBZb
IuzDiwZimCLXWxnAA8qfwdcUpt93sTdjNE/M5+3KWiuN0slkhaQ+KF/bQLeRoZ9XE3h54Kwdda0v
L3VmyPdaBwsMCfDR4bY3Kj0v6QGmD/NYBkOTgPUJkL8R3wumD14KoJ5rEXHJrT2P65VOonpcl+bU
OxXUxwGIk8iMsdzUvGEaWcJA6X4l+FowjEP3Y+CvPeika7xQInk+CUGe7SM9PYIVp+0czq+1ktIj
oXGM+47XMgDkRIALAIhXE/bxxQZf1yOFlbkOk8lXMhZ7wbcyjKnaSiiUc5hIERno0VA80mzKn0XV
zse+EBQYZJneFg2mUo1aDSigNuJE0cJexO2GA6zB5kP8lNY7L1iJAFWqRupmqPpWyACx7UIr7pLk
13Ygr/RPVYg2IQFraHrElj3k50SwM+yoTjGtozvkvYNKE3Y7L1r6oro1R6ipajRh2omGo0sZmDw9
wnc3tnERxu62S/H3kura05eY+zDMNMCUJrJkXSBCoL4ck4xg3OXdfQpKxDmBjTduFNHcqQ1UA+6c
rec6jcoj7BkzvwbK8lD2tnzjABruzD5kCeprH6QMsJwJ+IiFTguTmWZy0zC+62rgpQTab9ST/yqt
ftXy/AgR88HRkak9UBB+tytjraaVIRfuG5MZG+jUA9YauvFcjW92sbMPWwlEVZpmRNGoZSUivS1/
2PF3I965fln75uV9H9qPDsWQmEYIu1Lotq3yLUOKBhnCnRpZ+2rj36e3YTTUicG7oG8SsCXGUwO2
93Zl//XoutbQSt+nVjW1FOepwVyy0aNaxjw495YB0HzR4tpYAZFdAa5f0um7TDUTkwMFWK7rRXKe
TAgTwdx1XB0GOwdQPUCJ08TeVn1l+FOVScQ04JQyNcAk5dVyoXsCBMIj2cnUyW3hoMqTWqrrczNq
6NTZpRmAldtpsL/inSu1qoqSTDkRpA3gwZ3XHqpz+glsgFfiF352jI69a/nDsTwjh+LVvIfJ0R14
vjvtefUmE+OUqlnKaZMBd+lgZXRvPNl38syO1XF4gLJZe4wfkO1yzM/iebhPguIASf0lPDiv5U5u
CPkrxbtWbiWaUtuas6iPMpwJ1zrMQ0BLSmrWvSGDExQmA/k7rxH8CGHfBGMbQHkceA8YIyseJgB6
/tOExsCj7Gn3aPeFeV/oTqwfNCwkC2+O88bwkCCaPvYazS9DVuWxayFbyR1q0yZuERaO2/M59oCj
hbFCPsM8BlfzfmZGsw/vy9DlDPfSIix1DK4mOes1G59ETvsvZeXQPw4JxUNlyfqrM4MVzmzJjtYQ
Nz43HZBQHdE/anB/OCaiN9weNmKAuAqwWUG4cUHMLwIwfgp3ZCNoYLo+HuJ5KE+h3o1vJbLXzzjK
Mg8xWMk/WUdtIMlMq31IJlDEeJNOD0iaoEDUN+JnUy4Ypx7UZljgDCmW/nVVPFaklJ9zI9F0oB4N
7XuoNfye1j3BDV0Oeiv4+CAWzR0UA8ifcSOj1t6MUnSPYDVzFwY0AmCr8AfLOXmHPQ9Ol8NofuYp
sQ8z2KXubCDdFlC0BJla2TR4oUbgM2NKOB2UlbzXTKDtDsTKtDtb79tPkz7BwjI15VNuDcO7YHMR
3U1Rb3zFIi90Q50iprU0D5o6Sn2ONEZ37KfivSma8FiWsXyEGNUKeJbOHsZk55yNwvB6pwDXte2A
/wUzihtuHseTR5FzFrrIDOp8eNODolnhxgfUSThyHEC1NO5twPo+VxU4qy6tIuSStvW7GDB8YFwS
Ux6wGkf3Ysat6XF71FwbkJWlYKQ3JjCBlXMZk7cxaw5JtGcPuDaRKJszivkfuqMaCVBzBepr2R7K
lP+Y272c1ZUvVzW0rcRVRgFYBqBLQ/GQ5exrKtt45977qj/oMvgoy5gkFe1EJbYVoO2afqmF4vuM
1JFDuFgbhDD3OYqwSDwgqcEh1wuOFBUdJMlsnjxkEWlg4leNn4Bm4EFhkSORRYL1J/LptN1saxOK
sqipu76G1XTSBwMdQqxFk7sCsilf2gB/wYnosP2WtSpWgsPURAtMToidOxBTdvwY5m/bD16JDarE
BhNjCTuh0gD8B50gm9MfbYyQj9u9K6K1ZagqpCwNnFkNbWNcTKfI4LdUzicL+xl/hm2WVxRdUBIw
t3JSyFPBEt/GlZKrk/xJgr0FiqeR32nixmWgqrucJC6/AX7D3Dyf4+JLVgGXb+3sG1cCQZUowhcN
FOcoT4IRlGKgEh17PA8ZUnlB+91pq6VRrsyEqidqpHHAh5cogC1u/DpMcXxfhTk5V2GlnWynhtFG
KLn500EO5xtmjxwbR5JAVpDpMAUSHH+a9qXEIZCPMTL284nBZaxM6xP8DQlc04b45MBj7i5mdXkJ
K5BBzUiU2JfY82lq5+6IfH36gutE5MzVY3fUeKX7Xd+IdwceBfCznuq7tM+AAnbC5DGjlnGKKxp5
HLqmQ2UAZF0xbQC83XYASO9tnyPt9ZEKQg5OD1EkRK9Iw9FgqoADsOYlyqv+MLej6TkTFFTbtbiy
5f67O/mwrIaRek415DYHvZ8WBxCu+AN23bAS3N3orHTWv9fNH94g7aQuBWi+QUzax3S0LlW7J5T6
G6lXQkDVw9VRB5cRB1HW0L7/awnPijN8m4rPNq5rYOXUVmYBBJ5JvuaGA5dJ2DvNMn7Pu+RkaFz8
iOGvgVWS1s6XmNnNkUwxv8sI6G8EyI+dOr52IcYdw1GWbMCaDsjpHWVgNAAbQwWXH+Ixh78DYP2n
dKTdO1w3cQvDozeKrOadHe/KWKbKbBP4S8mxhHhUzOH3sVz8jvS3yWE/tgNnrVmX3z80a9ZUVSlH
HNvF4oUDEp+83vZcZSeWpRSr2yRNghbmlDky7ZnY0zeujUlKO/BpogTZgkA/WTpgqLBDrMuDnvR3
Vi33BqXrY5IqoYzy1pKdNsigmB57M3VNCe+mTr9tUaRqKKFHdkRaLEelE8CpoOnXv7YrfaVm/kfb
GEY5DC3QR4nsLkbFfkqkY9gU7r2TsyMeXlYA17rqEqYf4qWDD8HYLdDcGJlCxQPoytBdPWnN6DV5
vtPR1oqhxCTcmgA/y4w4kLP1Gaaxv2EXdU7BgzeSG1d3KjuxGkYrGlojCfCe6YDMBeOAVDu2Ez5r
BVAidATiaLHHrC+xY4pD3kriwfjRfCttzr7MUBztLCNXxgZVIQhk0OhMWoeZP58PNlwRaQnj4Z0o
XSuEsoiyBrPoBcESlUCH6Br28OpY03saOz4dMdhuR+z1EhiqUrAPcwxuFiKWNkdZ2K6F7KfQedl+
+BIv/xurhqoSLG1AiU2iy0DCMRcJVY3jYgY2dtbIa5+urJEp7BCjym5k4ADm1E53wL778Dna/vTr
lW+oEkGqWTPJ4cgbVNORz8dm8oF7zpOdpl2rmKVIHzoxrIPAdmaYyYiV+9iWeqC2b3/3WqUoXVdg
vShhoyuDNnnXo9+h1SIVbKfCrw89hqoInDrIxcHzwrjfwegTd8NwlosqeB3jFNR3AF0/CZBt/O2C
XGsAgNTU69zcRtPaUKBfhvENteSWZuw6S9bHn+3nX1uwLc9XKsqykggjWoHtK0xofO50BvIAElhJ
mgl1gbLNfmiN0ZxnavfzDW2zvFKdkhNsiZLGxgbffjTpgylbD3zMnYO8tfpShrwSObImMnRA29Kb
d7upziKKAlonb7k57ByaXYut5fuV7SITpLOHDIyqNOy9wTSDhFVf2jy6kdGnXvcijZRRbbb4xWlT
OPpUOoY7FsXNKzwrJt2TcPC+rbLUO184FlQOOMnwDjJwBRuCtM8bl5mFz4fX7fC61ldQV6qGMdGi
amQ5eIOj2bosH5D128Pr8WvVai7+uRNRa29RhkDG4I6ZF8S+UFL+AKnpoXXy+ujow9cu7UDbN7qd
AWul6dXLZcB8qm6KhBHYoDS7jZYj3bvOPVvTv2/X19oLlt8/jIjmlAKwpqVzMNnVawoX0Jq9crZz
57HSN5jS181psLClRHMbIMZmPXUH+7tg9712i4ZgaW2lZ3fEkVDTtEBf415PF3AfmarED+Pwfbt2
1gqgdO5Zi9IKpzVGMOcxtq11Xz+waICTXFm2d7j0Dw+3vUfp4TwNYWuAIe9iG19heOi15Qz6f3xn
aL+3X7DWzMqaZqjbIWpjiICQFdIB+tn8dAT7miR7O9mVilIJPGHd1b0AkeiCP26JWzmt/5M30aGc
dwpw9d4ATa1yeIDIZ7OeTklggfD4abZo/QzYLgxgImqcGoLsRGuAM9psWgIM9TpOwQFiMY7TjdCH
z6x212g2u2vqjN1FPLXus9CuHjTSxp5tkEWEB16YOycCRgCFIKeQztIr6zk+zI3W+jHsiB6ncepO
OTYB75ihKEwI28jYOW5aaZ//uaROphY4tzkOMDvOgJw1/6Wx0RyMSTtsB8BKA6mX05WBy4MGxlZB
F2XvYT8+ZWF6gC0pPGcL7PO2X7IyLKqEFE0TaTpHxRxYzmNCB7ju4mJYfyTd03Issf2OZexQ17aI
A5V+kie2Y7WdRYMqhcu7bGBBPAr6Zfvhf5Perz19qb4PwyHAoqCWshIXBBavT43Rpn5qIifebSWb
TvmU9p/CKW7eMvjJwTsdfLe5ratnIG2r31NdiSMI3HDt7ExcSiSEAUY3kIrDSi6ChQfpxGkQhFfH
2qzKn5HkcKje/vC1+FEmJBPkC3gPQLMMK6g/Je8j3+DlYbTYzrJ87flKvRhtKZy5h3JfmEZ9l/PJ
OOgwHzsZkPPvBM/aK5bfP1Q9HHTmkRFmw1FRO0ayKVzw0r9qsdP523W0Ep0qPirFfUZaWHgBnMeR
O82K8FE05lufJZ1bCwwOBUyzb5tWVY5UARv1XsyYmIb5ITJ/lHAOnpCuf1tBlFnJQBozrkxkElQN
bArpFLmOAadBJ8jCb5HY68wrHU1V5PSoKbtvMXmjyW0vtNNAJmwPnbzS2KrKItSHxO7hRB70oCCT
/vcI5z4re92un5Uthgr7mRlym5BbmwDUJM1vepn13wp7wGVn37D6CLferICreFH/1I0JEMftl64M
sOppPjRGGARMLKKrofZwrCJ8DCN3wBE/xlAtb79jpUnUI9GZUQzYejzhuJgTIM4h5+bpLbcpGFjV
7HgMS00bUotd9K6nXmRXByR5xoeEhHvpPyuN/pfa86GHE6sjRtVU1kU6vd9BtmSlkw+Tqtvm0L+A
kw+PR6anrRWtWQRCGu5UpHBLKpDiddvT/2JmPzw9q+REKbbGAJnPcLH+lRH4qjSftxt2pWYMpUen
BtaxvQRf3uDjRYT8a5Z2Zz26jbHjqFwn3SjHnIPQcKH8c1e8C1jw9UAT5PMeE2MlMFWuEzDmeVr0
ZAqMocPRNI6njR5czpsqR72QHmwHiT4Ftu/I+DmPzAYsDzLzgmQ7h4krPVe9ku6rcJ6BauEXLenh
GPfCoQNJ2Z+s3Om1a89X5mYrgWtaUwpkWsb3oQWbzuzzbD0VWuFv18/KvKaKoOLWygsN9OoLx7ml
G478XmvtCB6J2SN8+D7jUv02ExNVC9VMEc5ZtdK+5EmueyzldwYZCo/N7c4qZiWMVE0U/IkgYoN5
ctBB2JKnz2Cq3hhDykaRUjDzWwPbXEEZ9VpnPlcEI0RMbzR4URlNsAmOk1oAlR1hoHjNRxJ5VWVN
pzGT1XG7nVcGCRXUxBKI/ZNpqX7WPtpUfq+S7Hs97B01rIWRskVECtXcRBEqX0rbOc2DUfqdllE3
itrxUtEObpKs+bFdlJUuoaoIstjJDSGRaeoUT0ToLi3ubZAEmmzvSGulrlRpgEzbNndA2L9Qs3Tz
qPQk4Dc52VsbrT1e6dJhVNRWQoBvoJJ7LbjukukejsVvi1b1UjuUfc/DtgdGH2dzcNhmBXYYA/ci
Dqex7RZY6WrqrXZcd46YTVIEDXa8ME5NAMG+6cnqnfbk0GYG76MKRF+Hri2NBFjRvbF65bPV+8kM
wHIOBGwRwKcUdqFvWvdz+6tX1ozq1WQKtplBtBhrE11+5un0COzyM4+QsyqyCQjYnHokKnYO9FfC
R72uDHku4irN6kAgaxyHSQ6YS22u+Xpr7py8XRV5YjWnMlggn+oJK60pGGDbfbRyDsxI3IZuAcb5
58aR7AQTUig8hW28iDEyLiVoxseuEp0vLOEcZFj0x8HWLekyUdlnCwfCfsYo6PVhFFVeXkTFV4wM
9NAV8CHGykj4bZ85r9vNsdbOyoFYFyawBzb7OkhgnXusITY5ZGYub5tnVAQI3EpjxCWrA7sHY6uq
vyWa+XX7w683ra3e6w2OjaSSxGAXlkdHk8pjPQ+/THtPvLv2+CV8P6xCyTRVptlydjFK6EVyko3I
ZDL8ud2bgldGZn1pkA8vYFkzjVpvT0HUvzfwdMYy3UWOGRyvo53Kv14ER72BltwqZUuzJJh046dW
kfDSUqb5TWbuiRhWSBDO/yBqRFbDs8HEVIZzTy8pkv7IcE9zrNsu89ragUGrNmQHZ8jjiyBgBWt5
zG9aTdqqlVwotaKHmGoKANXPwggyrPe2rLwp/G87wK43EA67/m2gpoID+FTJOuhHHHQS+Ij7rKmg
Kq5q+8ir9Hjba5bW+xAHll73TSQ1dkmhYEHWfpgKX0/v47LamYCuh4HtKIEm5z7uTEdiLwuZd4PM
TvYnifem/+vDB8ww/v165mgSrM80vMQ4TJ/GFulerb9dMdcnClsVQwH9PJalTEu0L/LUuIAnRUcs
KHE1XF1DVje0nuOE46depvOO9GStNMpgWGtwDbUbB6wDwsNn3QpBNEkHZ6dA19d9sE74t66MLuwA
Y0nCizM2bkUNP2Sf4aAGr19I5Oe9dMyVMqjojxB+xfpsMPMCzqAFe0Wgd62W7uzN1x6ujIpG0+aJ
FHh4S19MzfkNMeqv7dZeqRwV9eEQGNRkTVwGORT1jzijPGFfq3uGbsPUPGxfcis7bb9prQxKv3bi
PMZ8DXSx5fQPidGdB83e6ctrj1b6cgZWlOkkFTJ2IP302oaGbstTf/u7V/qx6izX1bUWweGZX1KK
dAWXO2x6sMqiBW9Zy/5sv2Opg/89lbdV2AcE2bWAwU54IdhWGWkN1cnohjA9380zX3sD/bcTWGlR
lLLSwP23NG9ODE/G9GJbYGwlO1ueayJKW7dVr7gIhy0zQDRgwTY93L5aM8egNEAzPYHKz6Asrnv9
J1AKP0LZvG5X21q7Kz1bm6QFtESYB9ocRo43xk0LU9Mhv4UswB2ks/xbaZM+xzQfkBhlMLgR523y
Fo7DzynLfv//v395/tJYH+Yg4EqwJojKDI6O9I7a/NkywxtGjOXRSpcgtoAnXzQih3m00wcBCiOM
7RrzsP3h1/rE8vSlQT58eGODH2CyUlz0SBzN+TVixjEH5GP76deadXm6Mrk1koO3MBTQ/6Tf9M5E
Js2eKG3tyUovMLXI1ixQUi9w7EZiDbwGu70Z+VoHWz5amcOqBKLm1qnFBa7ovsMlgl8ckbr6XKTP
29WyVulKtIu+jOdkzAUOaEeP0be+m10t3dvxX5sI8P3qrpYSSLEF/MouXWWg/4JZlwKIwBJ6P8Qy
/SSnBSpgR3q/o/lZaQp1o1uETamTsI8uEx/7h1n0o1un5JajpKU0Ss+tQLq3ZGKLS62RyuVW/NwY
Wu7x0rlhNlteoHRdmhZ2FtdGfClEfG/WxZ0FM6jtdl5rCaXrjtAkxZEEuGpgvcsKE6nWwjWhQWw5
OSAvcPsta/W//P6hC3NOeQyUYHxp5pl+rqeMYQ+0uNBvP36lO6ibIDu2kEZLZ2w/ZvIHkkc496WN
G0O8gKBq+ttGCnUfNKfYn0d8ii8SWTgS8jT+Z/vzr01mS/MqvVkg/Xc5c44v+UAxIev/2W3h6sgJ
Zk3mYaL7nc/8HKcv229ba3GlZzeE67WEzTvOnY0vIZZdPtJf7iNteGjsFMwNZ6Y7FXa9Wbi6e9dg
DBHBYSyGKed71KYXbrwiDwwbYHvnBdd2D9xB1f0bVkKnfWckNIahX/eLV939qAMF3jPmGlFB3WyU
J83h2Q1b7eVtSjdPOFz4EqtCL0y6BybhjZWM1gMO2ced4lwfc7m6GY2IIWoy6NHFCY/xNPkm+zT1
e6c0aw9XOno3O9Ecx412Hov/pqZzG+fZifeq5nr/Ribivw1hyLRKaYcvT2P9EaK9c9a1OycAa22s
zM/VJJgxDLV2JomT+JDzRhczHSPP5FF1nCLJHnhUxi8wi9R3Rtu1sKX/FqaAf0lf2rF2pvMQ+7Uc
ct9GtohLk3H0m7ZPdialtRZRuv0oJiwpE0dckghQczLS+LEYrflY4vZv5xVr7aL09QnAzqKzHGSd
NwPA9ZkUnmPRm0Zdrm5CkdACYAov44uZ1K9TVvS+aO0TtPIQEhnFzmi1UgJb6eJR3XKZJFN0KWnh
tj3zWLHHdV6JLHU3Ohc4WIhMK75oVe3PBYbfxR/OIEe7mh5SW3/LNbozdKyVYgm1D/MfThtCMzQw
gRsR84By/GVF087ksfZopV9DjU1KGErElyjVnhun8i3a7HS9lY6gbkbzlkO7MI3xpbWasxX9Hgvr
KOzJtSZzp16uz0Vc3Yp2BjyzK4rVhwHouEyfCKGQM3yO6Y/c3mvmtQpSunPPMblWOuq+ZoXbVd+T
mwNI6cA2POBjkI8wIFEoIJu5cGk3/qe3/Dt8Y59nSwtSln/anrVXBgvVt5nDaatwUoywZniYZubl
4VMi9/RuK/gMruImS9tMejgeG6A8THrm6aFpuyXTW/DciPYrKa3O06J4vA+nsDhLPWf3oE0MhwjE
wm+tXQ0e8I5pkNl08VCx9UcJ60UffrTvyK/vjnBrI27atOWR6rX2OA27IKWVCFUdocEEEowBD3VG
K+vBOFfFi2NF4vcAs7zF+dfYGequr9A4V6b+yYnGujMzbOVI9l+c25kHz6sXfWqedZp8T/P5uUxa
kCEyuSMOWCvY8vuHAWPIsKItSxaemXWaQ464xa3KY5ztaVhWwokro4YZpxG8nXh45kbyLc+MX209
BkPffr4pWlW36Kztp8k08fnwYj5ZMZIrIWS9cLv4sv38laFbte1JBxJbMFjSzjyBvfHEci/S5Q9O
TBitVQyy9f4OhzT+9stWBhDVvCevShEOZNDOsaYvvj3a5wZIptvWfKoxgpmCvSHJFCJF58s4wkEN
3su1vjNorH25Mv07Ca6O65lo57loIPKxZZ88GRNcdLYrZiWIVEp3A6PqEdiX6EIt3wBrglQEwBhr
Z8+40gVUPi2upFuN65j5q/rc973X5uVhKLBJRTfc/v4V6BZX8bSkMxtLEBQgS5PyaI41/SSSqH6s
JxypGKkgRzDBMh9wqfhEwir+PFggZ3CzMm5rfRVeiwNq4UxtqZ3bghq6C4cfA37mcNz2SU32KBxr
zaT09TIz9banJjojQ/uk2SHPEg9Hyju1uBJkagoa79JM1iUNz1XDzlamly7VbtxzczXZLO5p7ESd
Fp6n6Rw6k2fYe6y/tc+m/46wszSqiixTh7SA1A/BZHDt0tLudkJrZWWjZplZGsd2rkrBDjG79jks
UuNUtI1+bHpDe5JpkTyWyHTzZAnzcCT1/oTXgvWbOR2LfIw2tjfSCRjCvKRnmyc8SEcoHBAZkbUz
wawEhZpiotnFkMMbPgRn+BPLXim5J3sdd+3RypI9M/s5N/UqPMOWZ0o8oKUdHMNkmnQTHjvftyt4
pflMZUZGZneRc4FD4cEcGi9z5ugnFEPkbfvpK2OPufz+YfqVLfT/BQSq5ylHzkKt5U9V1jOXhd1v
x7xFNITTBDVREDaBUSYoItCi8X0qhkMVVzt9cqUJ1MxAWZmyxtgWnsn4WLDqoNcTQq3bWbWv1I6a
FQgzHy3kA2ZfOAF4PJt9c3Rcm8yHvPuyXf9r36+0rtR1LH7a5fvL8hiWceK3pfOqpc1eqtvKAkLN
BEx0HBAhCyO+wAEibQH0JsmLZjfJpe+0+quYupx4nYnyzLGxd4+xUm3mUtiPQWXbek0tUzubpoZk
g/ilGJq7RnQ/qE5+31RvalIGTSiFg2lrnfNau9RC/6VR/QVknz2kwlqvM/4tgg1E2sgB4rpoSGXw
qwJMtwh8qe2PX1lkq1RUp8s7ZHaw4pKHnB8NHCh9s/LOObRUSD+m5nyw6g6m14VeV16UwNBv+71r
saC0Sx6HY5aa2EGD/9nnR4t+rUiK8++fKfC8bbY34azF9FKnH5q/rHEwMgocUvMa9LfI8BmA9VhC
7ZRihSXF1ezNsTSyqhuNZY8C5cEwdmc7j4YSmxKe+SzRwayjNmBzEw8/GY0gWLWxzndI4/jmkNb3
ZW7ZT2Dw5TsftBLuKis4TcfG6EZ0Mavr2zsAXu03ac5g4xVswu3ImOJWfrsBV+ZapuzDI2soulzH
0SaMGt00/R03YGoCEsj6+8Su/e2X/B9nV9Ycp85EfxFVIEDAK8zmwVvsxFleqC/JDRKSEPv2678z
98nRHYYqv07ZElq6JXX3OWdt+Yy79ND7Vih6jWuOLnZNWMYLKjp0+e1262uGZQyhbt2FdCxTZ3ei
wUOXMX/X+K083G59zbKMb+caApHcIuXZY1V5Qbk4+sWiNN+7CxinFuBXx6WsdyQj1VfSzvlGWnhl
XUyUZNf0tgc8MT0HXmOnAUhAji4KoV46FdEjrUYEltwm+th2M9GSzjCOuqYOPePOdK4JOwkozdm1
uGcfI3sJTKxkUWVWJ/wCNVbWUj70I/Q3ebewjUTcirm4l9/fuQdJaiKCrLZTocD9BB6Q7J+2yRM/
czbeGitbzASJEZRQaTpAJlY11aHPgsOY0dfb+2ut6cvv7769Rey9KaWC0vlofyIkey4KtqVytjYv
7t9tI3gNGfUIUitq/MLh8+3gOELANcp/3/72Fbs2wUIOzzV4sYIynfxL5ci3DDrMg7XR+NrEGGYd
uqJvwsaCag93P2Xh+ETDLYDBWtOGTWOCR0EUIefJUkUc1RFUKFmwYUxXaz5xNzVRQlUlIjG1FlqX
/fggJK+SnJEfEO0MqpiIsE3zmvT3PbNELP1cHBvRzhtJi5UVNxFEQs92ThbqgJEFJbO+G32PoDoG
POshtDu+McK1Towbpt+wrOs7baPaRv0krPzaknoXec3J7bqvt3fWygqZSCKo9zR8gUTX2YECb5w7
4ugX48cszgQPRaIZh5FWEM1CbP4I+eAROkTBlizaik2YyCEKsjsf2WH73Ivg0WZh6uA6aQ9boPO1
5g2TniDZ7Kuo46nKISHh2sfZFfdFsUXwszbvxst+9F1wGkhnOkfa+g5JqR04av/cXtKVg9QEDQmf
KhEwf0TunNEkoPmfZYhYLOf6JczBotpHLgAyo7WzmLVhDSu3U5OENCuXKYTXns6dQxPq+XHXPud3
Sx8ky3IMIfh4e2T/RlTMqkBYvAkimis78ECbYOPZEDR0n+lqiYcsEgkAfeMTourBLtRIqreD232K
hqjG0wXvF0gaq9MC8M69HPvpM6B/fRwMrkoHugRY2FCehqyc/lctNjQOSsu5a/uB6ljbk4BMd5af
IyB6VeyqJn8DFS9LKPQ/TtPAmiN2HcjdPWrtO9ehO0goB3deyboTz7h/rAK+7/zy18yi6eDLMH92
O2n/cgb5UoPXFkBob4kOrjVW33rW81PRdhU4/iIIiYCEAqpaTgMpOO6U7Yl6nnvQIAU6VqHtpkPv
zPeuVyOhWZF2VyirOVRM9YB2dMtz2TceTQD5tfZuN3YPll25DxlSJhsrcd06qFkFQNiFMCrg47lu
/2nkt8B+iootr7fW9uX3dwd1Br7VnHpjmYJSHsVcLee48Mkael/QdOAbO/ZaJ6jNNJNJDBJAJMhx
oopZ7cFeF/T5ngXPt/fpNeO+NH4xk3cjsJyB5y2VTToQ+AwoBGbE+fWxpo0joY9QeA4uFxA3IQhL
gre53Ii1rX3z5Qx6980c8HVV1IBSO5TG4fRY519uf/G1Q+wyGcZyTuNgC8AW6ZkM9A0GJFFiaMVQ
CgTydmy2EMNrn3/5/d3n+1wFXIfAYFgXFloIbsejG2xVAq41bpwFXjSVgdWxJm3BxB0zy/nTgw73
9vRc89aX6TEOAu3D+/QWoMLArySL8B89YR2hrXZf9u4j0Cu7nrSHKqfH292t7XvjsjeAnb2warAC
VdVDiGt77v6BaMjG7X2tceO6F2UBWKocgHAg+xlLK0ggPgKW+Q8CCsxUjlX5zQjJI1C3u5iSUkax
W/CtwrmVbWpmcrw5c+eyBYrLyfe1kqAj/+O3b063tUHX2jcMt7BtsNTbjQbr1qO+sOqrVIQvdv8x
l2MmaZDJpD2XrU6pakG/PQe/fXdIbu+ZtU83LFj5vrvgkQwwQQGG/cJv+z0jI1IRPQ8PHJxKt7u5
mumCKZhJGtD6TwXUHSBHUdYAO6keAmR85PnR42F5HLsS9DbRPKaWJuRAPUc8+ZDkXOLAsovd7W9Y
sXQzldP3WrsdTPLcWeqlIPOh0d3njzVtGDoUMEgjUIKbOvZUxhYfEyvXW/rp1y5gl6kzzNrrhyni
IygcZ57H2hKJ9pZnPn2n86vPAVIG1dXHbNxMCEjeTZ0fegDeeCDC7aLSxn0FMlcV+Cw2uljZb2Zi
QC6jtO2ZeOfIB17fVvEUTgltP7vly+2lWPFTZm6A04q1pcaRJD0az/nXpeE7B1HI262vrIUpQ4dM
3eLUXgcAUUH0IZ+hSM7KIDxJ6dWAIfaWu0Pult/JVga/b3e5NqDLTL47/Ubk52XZYUCVtx/zLF4u
lSXTuGEUawMy7N9vRDZDts87WyCGn20vFTJ/mycB9kOoA1osj/u2dzY6WxuK9/dQeJ1bMrPBSeNJ
JGz4mD8iIXfvFPlHrpcwFTMEDZBoL5Ho8s5ZJo+4pd3bbXOu3A96EDOiPHWjM1UEwCVX23sZhYeI
iNPHVtkwcuT1UeERlnVag+3GC+akn18jf9zYtmsTbxzeYV3yog8XWN0i9wQ8QwWKJRfxgUIJzLqZ
yg26pYMwN/B6tTpK8tJH/5D+3BZbH7/iMkyqwDnMaihD4+NJcada7xNF+mKmd9reEg9dmR0zlQul
5gZvkmBKG7s/Ukrf5gL3Gm23G+mBy/Y2X7aX+TEsWLMZIEPgP3C4lSoeUb4BaMnWHXPt4y+/v3MP
WqMAcLarIA2YfIIEUhbXyN6revOGcDWvc/l8w2pnK2zbSLIypRO0PgLQMj66YbckesEh0SKvErch
jVIaeNOuXkj+ReEF+SShEHIfBEo90a6FuIADDqSN3byyIUx6ohmvmCn3Ri/Vs/Zj6rJfE9RYiwGh
ItFvJWhXOjEDkI2Sqiyd1k9rSBHR/GmaX1B3B2qTbx8yeJNSLqcMrBE4AFNofiYZ+z0iCxyA3PZ2
6ytfb6YyA9ZYNh40HigpaKwAEw2nLqkmL7aIv7EKa7va8FihpwjN88iDaM8CHeLdWG0dE2sfb3gr
f6FMNDU+ntKd8r7X4mcz/tRb2norrZtJIcC9ByVsDUlw+tNrvmioaC31i/A3Kh9WpsVMA5VtGeZ1
ltE0nDM/dtRQxWrJN06JtW83Hhp+2bagJb/MzKjiPru3QBbRh/+r/WHDVa14EzMJBGOGcplb4BpA
VSI86I7ox1xtbZnLZ15xhGYGCFMNbH89k9TR7RNIM38q2Ym4ixwo31IQy2R9t3EkrVxrTM5Auxmp
1ZDGTyNnitspi93ms09EPBCVePx/EIzbsIK1CTPCB3XDa3uEQ0p9HZ4AIwwPYHLcef2i9rcteW0/
kb/9eyhkMdUMI7FLBtDXK+MbDmhtMQz7rWaZs4ASmg4ha+8iXYNCf1bzfpH1Rdh2AUkE9z8iOIsz
5D8plTZbss7XTRouiIlmVIzfixJQrLmqh0QGgFDFQx6KE1tYtPFqvj6+IDQmznaC0ZmlctJWnpy+
PJZefqqan0r1r6LasMfrixOYKHCI4HGng+xs2nTc3pV19oAi/K2E8srWIoax96SnNt6TQVqhcq3V
9JSB6cTzt+7KV1NslzW5OJl3N4dQuI0YrcBLAxhGJ3Xc2IhpQ10xB+iPWHHuIfDbxEQ7G4fS2k3C
TBoVLhDfHnhyUwJ0bRT85MvPCjTiU/1gF29u+8sOn0v+1a6fJty/Wv+lw2P3thX9CzK/4nrMjJIs
JwExX9ChVaRLWKPeqANIwEVRspzzk6vcmFrd3dSwY192/0zhMu7YQD8D8X3HHf/QN83eqYOtMqa1
pTW8hgdRHp15tZNmHHoMs1d+ElyjekRvuL/r+zI06esGe+JTL0o/ZQ5KSzv3lM/1l9szuda04TZU
ZHc+ywKa2lWTFFMRB9Bpu930yulmZprGqppYrTonlWADK0KeWM29P4h42WR1/fccu7INzCRTxxXk
hODqUoj3Tg+sacURPA5tyroMmrazyJK5aqwTCFlzHdeNo08WQLxPdJi8kzPSaZc3gwSHNGlYIot2
RrY2DyFrOo9/ogV0uksQcVBbMfu1DB37bWGq+0kdCwJeo+7yb00dLSmZOPvugrnwE3d6NcVdTcZ7
v8+AbRpD6xGM0tbebzJotypafM4KCnaMqQyDrXjSygqaPAyR4oueC1T3WlH9GZjMNMq9f26v4L/k
rNfm97Lh3/mUzgsQLuhVlUpdD7+z0rMgAMn1abKD9leOI+BxAva6TGau2fPYOtMQ48GRPS9zPx5H
6IBu7aUVCzMZA53BawtyweRkrZ5i1EG8qY6+gn1hK2C91oHhnaXdh17ZhH5aWDLJqwlqiUvSWS+3
J/L64RWalBOd30a0IXOVOqXlPrSQLYAMuJ6jZz34wxfpNSiit/vNcou17gx/ZKlZFg6JIOMpu/6A
+CjwANBvmej0XIbs0Ru3lJ5WMiImqS8kHaIxaiuSit4FsXre9PUjRJ7JrimrFmQwrV/vbK/pwF0w
TEhy+gPbOgKue5fABBNmTUH14md26oEGMGkqciIamBQoTv6a2mYj9bjWiTGRstC1NYrGSUX2tRdT
XMhPngLdPPl1e1+s7TrD+y4iWDwZ2IiTB94bKupmnF/RYlexA+jGhhte68N4fllTV8q2EFU6s/mN
Q4vovEACL3FZ/pFKMNw8TPaNGsdtLSaPpJbrP0q/+g265Gbj66+vAFr/2wNlflTbyOePad3qX6rR
DDWSg5PomXwb7erT7WVYcaEm4YZgDXJtAVTlI5I/8VkflmGr8mnFQkyqDadHRWTmgukRRIyHnrO4
pME9AwdKzxFFGXniIP/p0q3pWllsk1hy0UOmmVu4aVPqe7ecn7vS+5lncuums7Yclxl8dyCwStpl
l1dumuVzFC9wmyKZlI724eWclUvjbZFWX3/yBSZAtZQlU02z0LRU0PUYSPbQ5ewxioY993NISE/s
Bx2rn7c3wPVhBSZqDt6FE7sBcWlA79z2c+hZexvSCXKSu491YBjhOIHTxffx0q8q1Lu16lgOX6Lh
TgX1xkv/+ghQVfL3wihKZesrkJYuy2OpH7xZv7CeAmXmboxgzUbI3x3Y1K4qG6wxKc2+0uBZj1vx
4OsL/R+2ktnWTag9TdJZjwc5Wz99y1rAHxbed6L/5S7VD2qJjXVeG4SxDEhXeS3tmZf2fHkA8Q0D
TUK78Xj89/H738vSf+hJ5mKpSME4gnQLqV9rMoXPrivC56ILpy/gb/Z3Ub80f/Kq8necRmXcAQQc
d0JaHMkTCg5Y2/KcXdAF+X6EQMVBu6o6EEEiUAArxPyCvjxZozvfNZUXfiL+OEOmbRx3U1eHx8Cv
rUObt/2D0gE4WAa6Rbty/TbxH16Gsl4qW0h/TEOOcDDMT9TPoMTvv4e0HB+nKkN2qSvV8balXPdg
wKH/vc8cy2uUA9K6tIqgHDl2O4LqGTzbPtb6ZYzv/NesRF5CJBtH1ag++TUoKPPoQajm+8eav1jn
u+YrUYeSOqD/rBHQqyq1y4dvqtvibl6bmsvv71oHZbYaQf87o1a2FQCP6Sd38n6BcWcLYnG9A2KW
I7qd10cszO3UmcTyY6wblJswsN7F0TRY325P0fXdRMxX4YwMNNQCXHKWuNB/mZtgeRI8UGeH5CzJ
dEOPWc7ky+3OVgZkvg9ZkLmsDuwlndx/RNUnzMfrLtwiG73uc4n5KGmaMEDksXTPdHFVzGjrHSUH
oDS352+XPO+G513rxtizrcudoEYNISS03LtI9qnnAxRb9GJfAe0V356p656RmK9IHqGCT5cdGPI7
lIZy/hypYSOEvvb9xrYNdNFnfLaWtOXla27Np8gZQRpYfWYs3LqXrC30ZVjvTAM5Bh7kTVGlne3s
oJ7uJtnIfpLMfbs9PWvtG8cr86BQkEsanctedyfFp/k+qIB+ssp+3Ahwrq2AccDOLrUYzRz7XOS+
SKA39qv2wo0A0trnG++MAbRc0G6KyJlGrdyDb0x+0TXezqjRajY+f60L42itcynzvm7tM5RzGWCP
tZtgHAifg6vj9hqseA7zmTFmliUiZduop8y/ZyhmiFFz/xvXxH2pl68cyvW3+1kZifnkaGFmbQnW
2rSOvOdmQt2jdKuz7IatupyV6ilivjdsITQiUjM9UzHsiulI8bS8UJuGc7QvUdPZLDJpMjzURvlA
bL5VtHVZiv9eUIj5FlkoePTnWpAzFuWpdkfnyzRx61x1rvqSu3hwdpYd/ROIafzaAi5R284WFHNl
b5vPkiaIHC6IW6et1e9Y8B00DxubYq1lw/CJJVlmDV6d9q6bg0S/+BxOW/mt6zdTYt6pbR9v2pB3
Tdoszf00F/tRpLRCLYQt9/b86uovtzfc2sY2Ld8XVl77oLTNW8UPRT98Zgjqxaib/1MV6kl5y8bO
XvHEJjHgorNlainPzhBRTIT62kPRo4oK6CxvoavWbMfwAl4YRlCPh9DyIsDDOZdc3vVjhiDQsrQb
KMDrXTgmCyAahgTxktFzYRXdo3NhbhXQWt6VFf91ez3WejCuoCyfec1J753DVsa8rfd27idOuUXe
tda8cZ67DG6riuoqrYoqoaI4V0MA+rwturm15i+L/+4oDGgQqUn69GyH/d4NbQEFxvnNLfRWpum6
WTjRpeN3HdTDuHgjR4ZdFsGnCgROiHBPyViSvbzgg0uP30/E3ljt61vWMZkAZSvCMignO53H1tvZ
JAM6htRLUg7tHuoYh9srft2LOCYj/WL5RIEhTKd5JL5AcupeRPkGDnNtOQzjrqDIlIWNi2pf1nDU
ek4psVE2xIS/9SxY+3jjcFe5trwKFWfpbPV3IDc8tpmzMS9rH2+Yc7aAL8+b4beb1o8ja+ePJchc
f9+e9Otuz/kP358twKJb2XWaDU6/K2X2jbnixRUoRNdg+oxFqDZefSszZL4pbTlpjoPcTnOp7rxs
OIige709iJUZMkn/BqFEDayindqQ5XMDXJ1pzLYYPdZmyDBlDUYJKS5Zj1Ejsp3/CIf6yMLXEDy0
XeNsXM/XOjHMOQgqQkYUUp9D5j33vHocWyTo+oD2OwR89rl0tnIsK7ZshuybUYLUQ+LRXQTDfiRa
g+YttJOlokXsFdOP2yuy1ov7t3vql9punAUG582nwoni0Q+THvJVqij2H+vBMGkPr8jSJ717tnwU
qeUWaXZ+G2ZHVhTtMZpZcbrdz9reMgy7j8q+Df0mAoVh+MNX9RdtWQ8BdzZc65pVGMYd2E1TVT10
dpiGKiA0MjaVxVdaNhFbZeMGtOqsJnUnF4KP3uCA8yZvNh4zK3UHzn8wW9A9HaZg0qmuqufKD/gB
Iu9hwgY13clatZd40Vw/Cxch9t6WWQL1sujAO4Vy665si7hw2/lYVNPH9oPJ5qekF7mhB0CHEnOu
4qYPm4cxVN3Zgb51qkixJcK7srUDwx8IhxGO4AIiAbmtds7sD7904HR7PN7ZAy288nh7462c8CYO
zNFqUf5SYkCuvVMOiJamMoHGHOAb0ISTjxpvlNs9re2Uy+/v7hLegvvdAL3CtB9/WIKcRik/uCiG
G4g6mY/YDLg42PZubFoUqPQAoL5yPu9uf/uKeZpwMFyBpOvZiFS6k0BhTWPnel9FjnsKM7AU3u5j
ZSXMYt2wLPPBG3KVVv7vtgRZjcyhhlyDEDc7CPseCeuNwfyrT/Dfx6FjFrB6hVvnbo8ygjJb+NHK
uTzm4zT/E/JwDz00oFiniiJ7VVWfXNdjzxkNh6Mi4XTKSrs4iYX0G59yWfsrX2ImY5be4SOTWZNW
QYFqlwxFr9XGpliZzsBweQ5ZRqufLlcO2/+WT+R7bweoxtD1N+Cjdm6vZKxm+2M3PxMDJ12fFqj3
c8/Cm8+jVerE6rKH3NrKWq4MxoTBTax1M8qVc+7GHPVVBViMgqr71fqsO8oBtVfzUfDPt/fhiucx
mQ09oqd2GCU5t/yOemrPs98BeMrrhia3O1gxJhMUx3su7O4S3KlEADh488aGEXWlvf/B9i/9vnM0
IcLYQYiSi3Ogy2NTguBzeENm9oNLfdnK71p3Jr9tRpGh9qYid5ZTIrI2aBVHuRwOt+dnxShMtBvP
s6JoeLOcabg8eoU4lUJvTM3a2hrXmbpz+t4XoXNWwk/FiKpaVt1V7FvmbszOWgfGPYaFHcKMftem
E/gwdCZoTPLmLh/Z915BSP72BK1cY02wG0Pq3oaMb5tmgZ9I56tjDTFBpWXGfi5huTFVK6tgwt18
sSjkWLFLi8J+m0n/iqf7xq0muu71TKBb4HZg1yqJfQ6r6ivX1otnZ36CM+URVpCwykFRKjTq7UVu
1QqsVHc5Jvotk3MPAcCcnK25vpvFeM6ASLT6GhwJrxxlUFrYT7MkB6jNIYaAargtjpy1abxslHfm
Miqrxr0MfCBFR56Xbn5xN9PUK9Kajm8Yepajuipcojr1QLB6DEFTdNatnIp9V0/qHtwEhYoXBcGt
2GtDCapHt2henWmZwW3YBEMcLDrCw8RznAME0ZY8mZGdBofuVP8a66FTeJYyfwa01mmeVQ2pv3gU
Q14cq34RCYB9W6w1Kw7RN1wK70bf6crAPju6fJmyDnWlso97WcgNg1nrwP17EUrbj8ppxPFh63JK
u0U1X/1w1lDusNjzbZtcMXwTYEcos0D6jnVmmJuweSRjnUzep6XYsJl/83hXrgomU9swwZtMgHqd
R11lO6vi7oEXYfeM6D0/NaWjd3aZ9W/SsoICdadVkVR21Bz8DHxeU+FHuz6Y1YvTIO1u2x0Qkq6E
fLwfjXgTFeWJVr7z7WNTYdw8SOSjNB4USOnAo0dsqReowqaooTkvAJ7e7mLFqkzcnm1HE8pACue8
5O0JiuksKeF2P+b5TNQe2OInO5wqgAID8oCY1qPl8tPHvvvi0d95gwiUDYq0yA8qsKL/APVE9RgE
NZ039vnKJjThepCttGwxA8Mv8+wspIYsugPAzXRaouHT7RGsnD0mEyeZChU6pB1R+fGgQDVJUN/T
vRDw1Hpsq0xmxVxNCFi7gPUJKc4uBVau2WeZ1z4TuyB7hQrSjZla20DGOQ0C2TqsBtaloFzrT62a
CEqh62gjCLc2AMMCXGbTMLAoiuy6ow7yxAWNi8u3SDdXWv8PDIxJtrjEF4C/zOAtETN0iHgvyCMf
VLURWVpZZhML1gjXk347driXBuJgzXp+812n6uM6jEAcIyRUumtoXFQbNrfSn1lfoKscxFNCdanu
+s8yID90EdWJWKIfmdM+03z4dXv7/ou0vOJGTanApUONDbRdyLkcw5dK0jouikomvpuNMfWzade3
Wb5zi/oxR+QrpoF/FM58xAFVx7L3d8SaQLrF2XLACdomvAkOlY0K56Z148oD17oiZX+QjbBOoB7Q
ybBAyBpVDPVF8QFRZb8G8lQU7lerBhLbB3POxo6+dqm6kFBdnk7vXIuGsPZch6Dusnv3MAHeE2fR
9JVMtg+p7ex/0oe6ulrmPR2WreTuNXdz6dLwZmBwcNx6In2qrWyIR4ISz9BB+FbL0kdCLNuwpn9j
PuaaXfq59P9uaNxiMiK8Y6AuGMq0drzITwK8wu/pmOcHfxnpruiQTux7LxSxN4l8r/OWHGaXDEkX
VtOXWTIKLjmE9QFjGJ/HwaJfHU9bOhnrkP1ws7B/XtrJdqF8lpH/gcyTv86s9Oxd7lvVbubCRTFu
2O0qxhwoRJflM2Q6nb3QUX0C9BACFrzu8q81Qyo76kAE0yK3GSN4Su9sGjk7sdQaRLy9deCoiH8T
lIrfg6vLfUhHMJJ5kEmydm1O1KPsuvCZlUsLrfdi3EunGE+DrpdDIbxqJ/EyiiMK2KFaJNnJwIJG
68A8MPDL+lBO0/cWclKJJ0n0EAThdA77kB1RuOPdIStQ7hS4vxHm0tNTjwdtHDAwgM9yAYBxcodX
uCywtCAVv8PC/gJlgz70Ed8i0Ljmt6DQZea3tJaLoGE5nfFU3BX5fdT2SVTQ3W3Lvr4ZqZnX6spm
ipywqFMSKPFYM7ClFJY4TE7FU2DWh40H3rWD4zIIYuxFV0yy8nKdOtGviB1Akrthv2vfb5xIUhcD
KRTKeqa+OPga9jSFsTshsDF+TMeMmgLLbZ2FXTWSMrXZFMu2gwIsQP2oO7y9AtfXNzClTGWI/Vup
CR4o8r9FfP40+O7XIW+2rgXXZwiKJH9PfQ01M6CfJ5bSstmxHHX97QQ+OoRqR2d/ewhrTtR4KIS6
d3OZB31agRWSW+P8ELneH0+Eb+COetBNQ+LCYfXOkZxsdHl9QwUmrqS91EJlRPKU+O3jEopPs9Qb
C7LWtLGlpklkZS66EWj0EbjYT0DdfLBl44Iz+5kA5bXi6RiNn+gUIcZEx4+JvwZm8ROzCnCVtLhi
+nMKZsHdrLZiois71Cx36mxG8DwiLC1oDdwiP/lNfm+1euNuvNa8cR7atiegLo4N6pfzj9GVu75G
DDvQwATe3p7XwqA4CM2qps5ihJZWNKQhBRH5oFAmGfbxbEX3PGT7iSMZPnXR1jqsDefy+7tj1547
0raFx7Azq69LnuOYJ6eakQ+8hS6Duezad80T0DzY+dAw1Cc7/UH1DfTXqrrdeC+vOAuzoMlyoKgD
+D/WQn33uJW4swCbQbRj4u32WqzNjnkQVNCia1C8lOrml8O8vWU/+NO4v924e/W5f5kdw3aZ0J2P
goTsbHuWwg2gjbKT8PsG2ieMNo9T6NZ/JCL89t24gCo+RrbMP2dT3TR4C9jWJ3ecp28+mGaCuy73
qlekO/i3uQ/HH6P27DREzuhL6RX0W1Hnald2AEolpAaMJnag53ekbkPu86UDig4SZs9THVVnZrv0
rcIBeGiFC8pQyKweWtCtJ8PQ0p+504bfwxzZp77kkUzAMRq8TLbtfq9Un6GIFy8WgMCV1o8TA9EA
cYrixBuldxFj1sEDx0HKHV58hxwt3Ts5a/bUnVC1VcztcO+xXJ4yrTNwfGfzaXRwWIIttmb3xTRG
L3bbQRA5Cqrj3I5kH7We9UcMCjEuQHPtX8VM6icWSiuPm8LvjlPgt8eZqvKuWex2L8c6+DktUfYk
q9A/VH4f8pghzZ0OiEu9ajUivatHRuKAK13gDVSpTyAVrA+ZyPIvAB4qSDBDLvdpybi7p3bt/1GR
hkTBWHqfpinC8GnJojgA2+2ONqI7OL7Q53nQeBvWHKlN2revztBnEIZDGvyHNxN3X7cjne9l74Tl
vZ3VzXNY8UffyxqIDgDZHk5U35MLVxiohhuo43jFTnW1ewiopR7wW7kbI+GBdrLm+7BzrKTIgY+v
a8DI8bQp7yEyNyNUVAVlQoMmSKamXfaid9o3l9r+l67o/dPSsHlXDqha4E2PJ5Cb2Rwk4ig6hj7m
mDS+g5VkABJDo5HezUDFIbUOdgSG+l7EWIvlXtdV9tkb5+xUVfVyBvwIIOV2mlFFRTmYrgZ3FxZV
lORD5fxsXNF8zWdsoiayotelnqMDItHTE5Be5CckrEIo0/PxLdDYHlZu819WkNvJDALyOcFDIEyq
hcy/7ShKMqvtkoj45bKvuRfdDx7+YuruCAM/hBijVwU2yHEJfwQVSLwQ1yz3jYDKU0P91Jf1C8m9
8lBpV+9bWg2IFY/uAcDPdh+owvlfh+jqnik5fBmDOnwY7ByTKsvmNPVhcC5qpwBd4xDsA15D1MnX
44kFfYPSj161EEsaxFGKRYLrMncPGQSEgTXOq89FhG/mEvwSyeK2dtJYEBeaIU/xyK0e0ITaE0+l
U4Fhl1bukxtmwx68umOsaGQNhwHR+p2nrOB3DzJ/ZH1avG4VQ3Kg9ubxTKp5ecsHLJMNVatn0AkC
GD7wLC2gQ5NYXhY8Lk4QvHiLbo8teMJODRUZqNE5JFb52Ea7zIn6k8+j/jAvrp2UDWawsiu5WypA
y2nQttgGNj2AnADw1IhCySipWijlhqFu9osi3D1Dd9BzjxVC8btIEIFqEvwrawOdWiE2NRdllpRI
Nx9s7pJjAETnjkI0E2gDd/gfDwotdqW7yB9tXqiUihLYr1C1x9rW7Cudo+onzPr/nF1Jc5y8Fv1F
VCHEILZAz3Z7jIdsqHwZmIUAAUK//p3OyuGZpsqVRSouB4HGq3vPUId+mzShb3fEhpCe10CDuBCG
u0WaFJClqWBxCP5RfQe9EMj/QGgF+qn1CKH8XKBvwq7PTB26hHsV5KgK/jDAMq/cuE4BkKRvuSSC
VZt6KZ2huh1QVnCClprTI8Sm3F2ec+NJWzbEiibLNJ0wdwnwJo5jd+9l2sbfDVWqYywSjfQGbfTd
2KYM1UUChjSWBsA7to1SQeDZZX6AFQnbO7qHXYISU4uqBSAduGTDp/k8jtif4DSvvX3pVVl/J0zd
BzzuCrLpDJ79SC+WtY1mFLG+NgYCHNUg6gjMgYrjWkQsEfaNNz1MfIA3H1deeakUZvzP9SNs6Xyc
hYi0hy1M19TqOBB6FycZ4hSevSu3FCsx6Gcpo8tN7BLDf4gfKibiDOpeoAH27Y3fdmHh99+NuHoi
iLywbr8is3tpZ5ZYMTwYMksbiRU1ZA+29LZJ0a5hiD8P6Ny5LzZyD2aTMyiU5y5ES5uc3gwGhFJb
102RvukOhnbu7Hhcgb99PiTuHIVIJHI1tQIatyme4L26sYy70lnLP30ecLlz4CGMSimMFUR9Moum
/sMQ3h2lDXKgXcshqHpjDdi99BGzIDvJ+8kkVYkLeIJSFave++J7Xw3PX5m1Lrt83YdJ5TJSJUmi
OaBMzqYZu3FL2tYLtJWuQVg/hXRhPrHLh31oQnrDIGQBSFemhviYWm0FbfpUvIxgw0NX1DZvxo6f
JomcTJY0N7ykUP/Rg9xUxZjcFbqA13Wfrd0Rl4bt/6NwZHGTsTqljXHXeDjtiAZqjMlvhmPcX+9U
629F8v8zeO7crNhou6YYagJ6AQ7AJyhmeLejbOI2lCOSdboaRshuozq/Scu+nUL4x/nvjYqtJ1p4
vhNATKH/Id3a5UHhTvzcctzhEtZVj9ArMe2IFBP9UfmMVVj40NwPWtHaQKdNXh0ykWuALzugtWML
F1Zqs2+lO/VxaPvcOSSm3b0KIH9lBAteYcOktBJxoEZpIphw/G6DnEzvBBWN+X1vEPXgED8L04Zm
RmCVJInyTqk3gNyZuTHair1SNU4bMbjxxqTKCAhrjR+ldth3ouGauTOasn1hlNVTSDw5PYEsLaNJ
5RppRWSJ+ZB7+05k9u0wlNCB54m460vUtgxVNU5oWX2uoryXjr+Bc0UT8BbiF7AXMC9sk741XlNT
G3kguCF3nVOXYWYnRR3VbpkWgUh4/GAaTowud+U3Uk3k2WjYGJgWJJQtlt9LT9h7y+z9sKyZ9YtW
hp9socE5bj2DiCdlm9OdyM12jzQ3IqdMH0eNU7AqGfjFcAU5IkHqH7hTIpeRZW3AcBELTCmGbdYw
Bdl87VmR7vPqvrWdPKoZTK1iI4O2OOqUASsc41Y6bRO15li/F4NOt3rK2ruJVum29wjfFp3xo2jS
epu6FCp16QBAGkhEDQ9Sz+pCH2aDdeD7SR64itN7Q2Mt9xkVbwVpGbw7SebdE8B+4U7fKnbXtxaQ
BiI1kvOUjpYX1kSg4xDEAR4im7OFqB6ATsVvurTheWDa2KDDoavLNEwYaEXaqKyDEyfY34rJ95Jf
ddY5x86COW2IJCqy4bnX22Hj8/htGnMjAFjSDm1mN6EBv2gUcn2CW4qfmGdT2T7aH6c9ygfy2er8
cV+klrexcrs7tn5NTpae7K2sCsj+ZHX5ZE5uvoX6eHbArLJDw6+7fUqbMkxjO7/zRpWELvQpjrjW
9YFJG4H6g/BubduydqI2JMRsDPtOuSzm2wm/fZJWokMLFIHbUVDEMRziQe5otuHgF/kbrGRJiOBJ
bKQCnxxVLfrAMb7VaFl3zYhpGsip42NQmsIFFjbrblIVF5vWbe2flRjs28rszU2ikUsrutZ9p46T
76e2zo9+jAgoYK2SZ6tLjbM/DSPfenGV/Zen8C0qEHu+GN74x67HYidAVwvdFsoVlj2SLY+VuM1k
r14m5pd3NcEVJExGXT8ZKDvDKwPY4gBelyXfOzEb4AUNX79A0Jo5m44xsa8ZkeDjUxmZU4OduCzj
b30eD7ucltYI3w6DYCPxifhF/KbIQuHbxd4FwQwahripPde8Rpklt8q2CWw/r58ReeoW5MMBan0j
kcNNaerpLfFN/Nu3bRKCIpCdjcrBv0vIDYAtYeUIE4d4hC4KYm2OrTEpUb4AaI/8d30bXtjq5yBO
5hTOMOVwxzAur4mKDY3B9xsBfqlXAoylFmZJi0xjPsZAIx0bLR1cMhsztMCtHXz1jSVqrY5wOZo+
O0xmmRdUcdqubRD4ldX46EiNGqV8vN5Ff0XVPnv27AvScvAd2SO97z60N9m+C9xw2wWHPIrfIV7d
RPRBH72jseObp/S4d8DHelVfwKhf4oJZwMwbOIHVgwuxWglKpPmtstci2IWQaY5Rn/K2g9U0Ci+T
NJ+gF/YwpPS2rNw/1zttIYidY9Sxrq1LUkacwFDcuX0ZxoQ85kJu2pIGVTu+++ZXqNvoozn8HEeQ
jxAWfSTbsYumVieRUdpse/1DFm4Uc8z5FIO+6semOPG0PBJCI9OnD9Kadrr+D+pum+utLHXXLP6D
ADqMc4p6hKuffRB2xQPk2V4hmXXX5ONjQfl9AseElbr60tDPwrsClz0c7To9MRya72DsWK9JW5dR
0+Fo/dr3zGomfHRTHya5/IS965H55q00/FduyV3VFkdKmyc3EbvrTS3tL7Mlkg5NJbKknI4+bmCT
hwBNJBvV/8zaeP+lFuZAZqgmw1NijNURJq1HlVT7VJX7zsgfScmj600szLI5lpmYpU+H0clPoqjC
xCojazymqGhrKgKev1xv5G/R7ZONbI5izkll0KbKzFP7Rt+as34ujmOOenXQv6kf3d3Rf0eAbK6g
RT4vm0Fn/N8rTevT3GqJ2Z060CXTwG9rbgSgwrDtBBGSIymSZjPmMJkMynww6q1rZGuyZQuHgTtb
TSLPLZy1DZyHYn7MXLp3inwFK7KwdubGHySh4Jr4o3vM0jcKDZtEvyL+Cq4P0NLDZ6sGCWk6Nr2G
/xCfnrOJ/waVuAigv/y108SdHZLtMMStNRQeDDE8uSOMuvuxofVKFXxpDs+OyZGCq2GksKErwH7a
wfy5uE8dA0mpWosLPT37XWXeWqJnaXbNVj1HYNSjIggJAeiZ18PPqe5wTZoCnUF2L+sCZTThAMDo
9YFZmFBz3HPiqpTVIwpHGVx4A2Sq03fL096P609f2MHm0Ofar2Se5rY6pvaviehAQHEGmcfAr9XK
jr/0/pch+5BeKDI2+oIr3HpY8aey6Q9brWH/FgZi7vzNJojMwogb5dMmD21tnZAPf+h9jeJN8QxE
S+QNcTCy8vfX+mq2tKXHGty8THXsgVjyyibsUS7x60v2fo30u9RZl59/6KxxMt0ewTvEpUwXEX6W
QVAFd5zr779Qw3Pnnh4TqyjYmKAFDrbdb2I9OWE3tF3UpMo+A7naRfAerbeCWO4LJ4VZRAy3FBo4
nZGeuYeKV8UHp8T9KWlfpYrtQxzX/NTlXf7Wg5/8yyhXVWUWemIOenWNkZleR8qT9s0MgCO1MUpf
bq/3xMJ2MbepMJHnhM+QwaHXqvYJKhl1ZQRtmoaqJodarHk1L0RWc/jrkMZxziezB7qWbF2H75Ba
DVWfnFmaH21zeDEdoP6vf9JSf80mp8MLaSKrk586562hpwne0NcfvHAwzGlwYmgpm7xLknbID7xu
vinL30Po/Nf1xy+99+zc0SZxVa4y1IozGxA49myZ3Z/rj/5UlhvR+Ry3yxyvY9XksqN1qVslsJKE
Lg7mLzeybo/cTraHD3QPjzHkN20+xRtRKOdrgdscf2/Sig2twoOr8VLNSDMLIPj+PieTCTq0Xgl0
FmbYHIQPVeWhzZxKnGrkHriqp8CCsiE3IAch95xVx0yt4BcWpoEzO/RQ2YhJpnER1YMDOOpjY+tt
mT5dH6mFh8/h86ynuqI5w3osij6MGzcLert9nKDFc72BBYqlNy+ajLU5pqNIHJBd82KXtRw6h/4k
q1fkfqcbMXXVs+ZVFiUyMyLq8ThC7Rj7AXaJrRBIro2iX0Nq/NVbm8fC2MXm99+qV31/keg+9QYb
7oepyvZI+NEYuaw02eW+n36DbegAbg5xM1TSE1s6UdlLC+e/UfuRlXnlNilZboZpLhO60QkdDgZs
534BbTPhFAdg/d1HsCihxc6zdnO9Fz9bq3jv+WXEt1RPY+h3A0/Un3nlnqx8TWvksxlwefRlgn84
+GLf7xwXsuCnEYgPFOJDOOUGfPjai8/LWsPAagd1zeGEbLUf5HrkYZ8mK5HtpwUUvPvc5TXLpBxo
OlAwEOsLLVgHMtUQlCp/FHEhDnXf/ae78pn3RQ6j9hb1e73v69wMFCylA2TwVlbRZ6fa5T0uffuh
D1E7ZhPvU9DeRf3TyeRJelVkydENm7r5r3HctfzNZ0HjpaHL/PjQkA/NXNK1EGcymKOCimcnj6fP
xoQaMxzdHr402eb4WQummGYqQSaLrQoM+Ni4I3m5sm0uTOQ5aDZReZGUtCAnWdECUmbjvVSryvhL
D5/dRSwrG2RsNdBLZ8O2dU9FU+yud8nSAM/34DKzi5JJnO6Olg9QKFEPRtk0B4NaNGpFNZyFW7gv
1xtbWJHzLBpLxhFliQqmRHCbsi8OgMNZjStf8lnkjhk0z5vVg4mw9iIGC0WsoO8fPV0EvLAD4E8C
0U4BhFoDk/tfCGEurV3m8Yf5ama1n2LR2yds83DTpVByJRC9XFl2C6thrthQ5onwfGT90FE1bhti
D49UaLjwgPfeyv61MPDebMFJPhgo1cSQlob9Aevl3u/Z0TBGiELUAaoJKzHLUjP0335SxQC78Kpr
TorAK3waw4nyQ9+f6NRCpOQLN87LYFj/NsI9GFePRgo/IWnDSzqBZ0kPzgQ0W2tjZbzJX8zmJyfs
PNtk2T6QQwaOexRbq1Bpzh5knVf7AlzSOCz7OL4vcrjtBXZv1j+4YOQp8RP3Njc7jN/g1KGytIVq
MH4VMCfD3yGRBEQi6DrV3paEwAapR6pMKROWONPoHwEaHG+YYaUbu6o8BJZOfwMkmxdx1+r2WQEk
dZA5OXsmZsY3Rt17QV7JbBPn8g2hCQpcsoeR4GR7O55pNxI2fFK4H0OVkPn2oU+l+1D6TR16ac3v
ajAvzwDExTej1UwYK/jzBKhqkX2OAukJzEt717oSQN8cZXzYrQtYIQo9PSshk51nuRA+d8bx0CI3
coghVO6jchnn56LzWehSwNV6nVk6tE1q/4xHAkO/qXJvXa2mF04JYCfZf/EgT2NnsZ2pSpBDoId6
X7gdgPD9NjGyOBqGLDtOZp5FDhBPU+Cz2D9Q5YgbbiV5F/Wwy4TPp6aoSzVdaHs0jrQS+eMEseOj
ibWaA1oFWlKYmp78LzUAxwLGgj1Xlh/rqBoSsjeb0t1gSC0b3c4a3GS9PBqkbaLsVVT3MoHvwgaA
6qGI0rbgX7PE8Ob5xaJGCc3MWY8Azpn21mDEJ0fF7da1nPxrx9+cy0RQC2/MmPvHLB9DZOfjgPDV
BbKwt8+TlEaXA2orgHEDyYaEo0y60EF1NISB99cIdDAK/XeZ04HDUVfE9am1i52j2j6UpvHDwFgF
QADepKOxttqXPma2awmkZWD/R6HN2zfqkBpT+tBNKYVPItOv18/ChS1+nrz07d4bfTABT41lTBHN
3Grnq6x711U+QSXUK1b2xgV1Um9uUCyHvitFB8UX16PiJi+bdle3Iv0FWcHa3lAwHALS1f248Xhp
P9SmWfzJOzt/hdiW9xUCCDbouZpDzrnvJMCYnpKxzcO6mbYVTunwSz05z2Yy1/CnIiPipPMW6uzV
L0AbIBZh08hT6Zpl48KMmPPzeGVnHk1x71fs12CZgaxeYJO9crgshHfzjKk76do1UBvBis+OvZvv
kcxZOeYXptlcFAJsOUBWdYl6X98/oHKtAncYp6CBl205AS/9tSGYRUOeom7WTzaIXYKHedG9WV29
rb34TGtne72JhQH4C7v6EHBlgBgQ6mTi5Fo9TJtKcD9b8BE4xCBW0hF/rds+OeHnGg2tBRyJXyHn
q8wclKuhkOlLqQj4LST1xAG6PPw+prpAOS4e9kM7ens0nzwlMR3DtKbizAhzd37h6yfHmtrQ8Vty
l3QWkqBDz3Y26BrPLJ5sYMw7YAdph6y4AaTIIZEMqmIM7lZAf7UEBuUelWvKEAsh2Dyh45kJMSs4
C5xS69fA3GBA+QrepkFm/Oj6tevw0jyb3SMsnL8o8cIinjgQXlBcJXepT/JfpqmcP4Q7a7TzpaUy
25mVYsANpX13cvLh29QMDwnXK6HqX/Gdz8Z/Hkb2/mBUJjRncKScCZWgwcIxNz2nlgV16rzQ0741
CzpEoMTIV1mS/rtACH1TUqPa5RYnN6Lr22/U6pyDkml122BZbxhwaWDoNACKQLCq3QuWAmEE9Zcf
jm7SLRMJ+dn0Up6Qa213yO42MN92Zb+BWT2cBWOf7AHO0VtYEbBdVqtpbzdQmbWBp7xnZpq/mKW0
QLW2M6DsJYMOQiI2vHCRCta6PiSp8oK+Ik7ktem4V1PBD7ZsxtsiUXqfsMYOO1pmR1AzMefB7RCh
QqI82TOWDhvHa6spqLt+KsMutcQZKDhbR0Vd9fnBd1P+K2U+3IZlCnUEkpkvROH2e33Ff5aIxKEx
51q2gk9eX6Xs2E70lALcWLiR3Y4RSXygo5Kg44frDS1sLXPSpcwU6g6F8I5a6vZog2IWMbfXQO5Z
a2LdS03Mpq016Ut2ZpxOeXz0xYHr22xNl2xhRcwTnRLaEa2OG6hVJFDBYU5Pvg2QQVkJUxYG4f9q
JtM4UWh4ocbeFBDtNR+sojyWxfg4etlOluzPZE4rw7CwhcwrKE3V5KnEfosgAYK6XXqATGFQstcy
nXbXB3qphcvPP5whbaqZUjk8NY2xBxRxqHCMg14yOnUAxaw1IaaFsZ7Lh5ChKuFeYA0nGeeB1b8X
2SZJk6+dtPPSiVkLADCB3j3q9lnYqDJBJp1Pt4b/53oXLc2m2USVhgFCVwqR0rTJgTQedEi6dJWb
upCjmVdPFK1zq2qzS5Za5zlM3NUYDcCfIreReZHl2Mk9UMlZyEXh34xprYNe1KkI84w6GwHR+W0Z
o8IfxC9OAGCfZfdBZjEeWAX8CaBE5odNCpCwmBrOoUyQAf8PF8DQYXF2LIfWAR3AEw/pkI+3tsPE
RsWbIVbDGUrX4MTVbsZxg4aYfUKnIXLhS/tErNoNsqnJASQds/ibj6rIe2dQcm+Rtr8pxlIdfChn
vKo8Tm5yo7bHoM6LP60xGJHFapTuVd9l2JC75laMjoLDsZ1qBF+GOnBQapxIClFs3GKydjJnxh1k
3YW5uT6aC5pgnj1LHMLA2Uq55RpH5AW2lSiiWlYb2HeAa7QDSPqbF78abnZj989w89jghrCydy/E
HPYsHECs7CVZ3cbH0Wz+eLoBnBvUV5s/5vZ0sr01++WFBT2XiZmgMuIqC0stVoDgljQqCMzk3G9Q
BYyu9+BSC5d98cOW0XFt5tNF5NgGwE8zHZjsR3cBx3tfgJnglKOXHvzQgJEQXDRb0ziy2IRPYB1A
b3CfsSPhz0a2BphY+orLzz80YhswhQA0KT42/tOIFGKcThvl30hprmxLC9vG3Du8T53K8ZMJyVeA
/jdAxt7Hqb8mBvT5ZCLzLnK8mkGmACcn4PTh5Fgkisv21py835D2t8KKs2/XB3thuRA666camrs+
1d1wapVWsIcHn8Co9UtWN49J71ob19bvYvQfqooeYQt2G0NpLihSsnJX//zkwHXm32GKhV9yFwHV
sRV5JBnUbOxuM6o1WtHng0Tmtuvc4qoFPxE+okn5SLP2eyabNcrP0rNn54YDKRRqEYhNtcze0Unc
khFG5deH5fPZS+gsLh/d1vQMXkrY1sIovHvqUYMUEwib7pqsx+fnEqGzbbKzlG86E9S4OlV6G53r
l8qkd20qtinxDhnSn0ld3VcGX6nvLX3RbHt00oZlNTiQpwkGetFAtPfMiG9tx8l4B8ZwDYa7MJ+s
y+d+WPaD2/eaGEZ36stotPIwr/xw3TB8YcjnrvF1OxhZ7yby1LC3LJbAqv28Pt5LD55tiTBchs20
h2IjAITvAjanjVhD1y5sJdZsgQsoNiXO0F5Uy6BAYznnXvh3BLnyoDJ9IOD7ce0yiS7+/7skmZup
J6LOvMkSmFHtRRcNDN/kV+Y86qb8YgOXzvswtkZnMNGLtD/hbgG1YChfxvcJiCp9+3R9FD7lCWAa
/pXk/NACAv1E0T6GE/V+2E5hvDM3aVht6F6JaLzVJzfS4c14I87yXO75g/Va3CXbVXTFZSl81oGz
RT8kqaypf2m9h9hWkBSAxG0MtQGylgWOCLxf1z9zaY3Mlr4xMdeB1Ig82f656TFMsGyKrj96aR7P
VrlMPFfbnXHR+ANbFyakuSy+9ui5E57heBTYKby1NsyXOB+C2mtX9qYF7AGZpzp9BxbhllvGh4kQ
ez9eGK+g0Fg2OGeuVZ0qRvvbOlPuYZxsmMwbrd5a2AzexngAWR82NcNrZvb6G9yJrJXPXVi281TA
yAVhRiKGI6ouUyAtP+K5PjfwDe9qGK/klRPvro/Zp4BGzPp5MqBo+hi+ZG18ACENFlGZth+pEtbl
Zs0UVAF59ZDQxn4D/+8PFH63nXbDftL3FLKR8GftZIAOGF4HZfFn3UszwEZgpqFRxXEQuyT+dv09
F06subIMgaIGo2Ymj0zq8Sx5nt63Y2pDM65MbyAKkhyoXXRI9gGhdh/b9pqJ1sJImLNzfuzBDeuA
PzzKih3AgmYbv5kO4JBBQZ4OoWb9Cs9qoaG/qKuPuw/Yop4Xo6HywkDSbVjYZw+IN7d5p2kbXu/F
pUZmmwwk8zxKStoeRxSu4gG6J8nESsjr8Y2iDrL8UAb6WkuzbaaJ/SrVqu4gFWCbmwyc7rTqHqUv
H1urYFGmnTUFtL/78yc751/o4oeeI4OPXHScJqc4BhkuhApDl25Axpj+1I0ldAgCW/tL21MsNzQR
xX3V2+THpFLvTuakwWnljmCCuyaECMEodOy9DxrgnUiq4aCHfEgCnRh+xJA5/Nm7nv7JrKTgUV7g
RKWDoiv2dgubpzkbGkjauD0S5u2RZUV97srJ2ba5sZau/hTHiWU+1x7qE1Y1pPCaowRdkAeM6f5c
KLj3BgaLUc/vbGrc58XQZ8Cv+962ozIDnqTh7Z/rE2IhBJwrgHUGBLTMzumPuoxN6O9kuLx6rXFm
4Lruqx4A4uvtLJxvcz2wLBckHcB/P1owYn52BwGMuQ/NEFgyGCt70dJQXVbXhwkH63lkS02rPcL2
Lv3hVEURwm8ifrv+AUtPn4VsKC1VmAoNNgLtuFtpcf9Mk8Ze2WaWhuHSbR/evWqn0i/iuDmmrkh3
DURnn0Zz9I6TBSZ3RdXw/rWvmMUCVQsLN4RszZEmRhtCvGcMISV4/5WH4z//+xGeg/xVOcjkxEYv
rGKQFIzf159M/iYW/383Meco10Sk1gg9qeR0+m4Eb04AmYDglxexcAyd4PY2+p4F2ya4fTudotst
/twdDtvD9jaKbm+f7x7B/goOj8HP3e737vH34fcQ/Jabm/vd4RDsDs+H4PD7hgXhZlcGm/PxuNls
vu33+Ov9+BTuj7vzMcRzoui0D/E7m/AY7k+30Xb7Fj1cfi0Mo7co2kdv+zRYK8UubAzmHNfpeckI
dQPsO/D7kN8zx7cfYjHC0IzRDAc9d+9IJtgGkikEVLaqAY2VNs/Xe/vzqW7OUZ90SuI0a0zvgNLi
zgWCopiylSmyENVBnvLfOTKN2km73PUOE8on8AkNZGnszeG/wkXmVEPh1Xgcs+G+wTURjVte9s10
oFHm5tH1b7u089k8unzzh4VGubZReJYtUDimfVDGRN4EMaqfUIYsvnRvBHH13yZM3LcqJT3vYEJf
prZenGJtE/Uux/Rnbz87jQwTMiVWa6M6BCb7nonie+GrtARyikJfzMwJ+d0rCLjtDRtKFMUgzOfe
nsrnOs7cPwrA653Ha8LDDMVxE34ZcR4CjEMiiBhvsraIEC2O+1HZ9EEge3zTmEb7ox2ggxIAGwCd
Y8NpIc1me4M9hnZv4RP9HCR6vxt3WlfIeXqACJdZh7R3CvLtnSs1ahoaqUSI3sGOFhMq3oGR4v/2
aw20Wn7hMLog5NgQzJBGCTEzvAVtgY1lPvd3E7X9KehZH/MQSk9uhxtACpdRzx5R4oVF3gZCv/iN
HNX4OyvuoNY/Ub1xq8Q9w+RieIarAo3iVsa4UVVtCBxA+dZC7+DOhRxaaCtoOQKX0I3BYJjJtyrO
kaGgkgL91tIw72R74xremlPdwrqaQ0NzfyhJR8z22CXwYAh8s7Q3mhcFWzljF57vz4K7LFOplYq8
PeYwhbyP86QIM96s2SJ8fkTBSODfae0OnQkJ49GDGeSjYo9aAwhuHO18WgmCF7Ke5lwzyck7krNB
oGjtN+d+NHagZR262of1DTTr4LZi1G1U1fQ+AW8HtRZYcldrZOSFrptLKiXwv7HdEkk2ZGaA6Ljr
kpfr+83nob05d3KcTDLa4IW3R6iidRC58Kd9DUnUO8+T1hkycuVRxhCYud7YwhDNJZUqCkcMWRfV
UUAf4zTVubwtRts/2WYhoeA0tF8zKYMY5b9zIW0pdTpwxE+mMH/X8CmRUFkMYGi7MpMXPmR+9/eU
gugwkrkwdHc3dUVp5JbZmbTe2ZWN2H6tt2ZHETVTT+Hi4B0EABYDiAxe0PXn+r/rT18AvJlzX0qV
QYYJ8M/i6Pi9aQcx3JzGPWnSyg50jhMobKU0skC5VJJADL1DgzxLrCawJLSLIMy36lK1NAdnB1Ii
x4Hyzi0BrmD11kh49p/qB0pC6qoWGjFDddJErgHgF05YNjujHM2E9D3sEyZnR1eKGzOlD4bnrFzI
/s6BT85ANtvlhqkwNRfSO6jam3AgWGKEnU6q2lfETOrGSTLrQF1LPpJKQcEdpXbrlFT2dPABiy6g
hRmPUcWVEUGUnr4oG47SCa+SlddbmLlzaRHvctJCzV5cZHa8vY5jcgQhU98KTTvw5MA1W4GJLQzq
nGmVqBI8D9cpjyqzqhpyNrhEGqqoDq7rFRFJESaKcVozUlvYH+eUCWUOlZOVbnvkUwFvPgLdyt6r
vZUk8udP9+YVIatnwqwKHPpVd+PBCiIFGuj6KmSfBkwenU194MSNlFSaHUtu9Eg5jPRQWs6JpP4e
iDcIcRXpN67V4/XWPh98b14hahnA66SFZ3I8RHU7Pgy9uqlUfgIN8+F6C5+POrJC/268kyB0MA2l
Tz1xoL1bB9STIS90CKeSXT1+zUATXkr/NuOUTp9OHdXAxpcbz5kilRyuf8DCUM9rQYUiqahQ+TrV
kwo9CQOqavK/dLn15pUgAh1wCHT3iB0T+xWqCK9c8l/XX/vzTc37i9X8cG0ou2FiHNKUJ6ewATOz
fLiaNLGzccd25Wa01MJlTn1owRIp0ImGhzUA1YKTln5xC+MiilrDsEbcXer72YHnMIN2dTzClKDN
32VanguRRtf7Z+nRl59/ePs6V8odJ884ChBM0uYPh6P61548W8G5lfugaoAtYFDgCZ1TV1cre8NS
j88OKun0qtVd4R/tSvSRhg53FTiUF78SUaUrO9tSG7P1ama950BzwD/yvgkcyA4o9d2G+Nn1vlnY
b/6ycD/0ep6nEP6x0hhSzyfgmQJXv+G+Saq1++bC28/LO52bQDZOm/7Rmm77xA1J8aeWX3M9/D8X
na7xxkG2FpSAEUhuJcTMotQX7kqie+nVZ4OrU1mRgQNenha4GbtZ98D86oxs8UrC7pLT+v8oxPsb
9X3o+pRXcZuAjARr9poGRgUcewyTGDWelDR/wR0KCtQj0nlQr7s+1n/pMZ+1ONuTiYujpWZ0OA1v
vQ7bd//VkWg4cG/oFMSBOJvP6vuTeGDIjD9db/NvPfqTNufZ4bFr9P84O5PmOHmvi38iqsQgBFvo
wW48xHFsJ9lQyT8JkxgkkBg+/Xs678aPYpqqXrnKC2g0XA333N9ZZjeTydRSyF2yLvCwqwian864
pL9pS+sD9XP1tSytujtMcqDPc1VVh24GXl13HPJYgTSNE1uFEH/E1MyPA+PFb966YKnb9qTiCmfK
Y4UbW4gUJZDksNcOnAMPzqK6rA5GGS0zL35BoFRfKaYyL915ex4ZWW0nomvG+3YWaE6OkrewdelD
ZS1b4IqV6UmMHiumYBjSXqIWF+BwXfyEdXkGX4S53xjjHwfdf7DMg12GYLri+ag/iyAU3ymYQV3u
+Y+nzz8k5jllfuMjXZHkTa4Ppa/9fV+m4hgCcXO4/IqPtzL/AJl9zpt58pSXKEARjrZK95C/zJB3
q3thg3wvi42d8tq3GCsrioct0E2DMcEJnL9aQeDEelhsuJ6GatmQz33cFcxMb9ijJJOjJYzihuKk
R+/Obty3y+209uhz+72LNJWFs7xX4qw9FPwOmxAgMO1flx+9NkCNlmnBLfeaxrETRv6E4c+s+l+h
7Mitrnz8uUPe/fKgQYmBo1IvwUXOoyPGT1Nj/SINUPbAcH697hPOrfbuHWkwBq5FsJ/sECmAlI4a
b4ny7AnWkhsbkLVGMjYguB2kqPcDGgKEVvgbLLEevwdZjRi3tRH5kCAH8aWZZMyHTMMeB4Jw21Le
rS1FccgDmX2Xth3+oiLLHzvP8+6ApR/iqZLBHvhi+GQTcN9Rp1r7GBbZhEokZN4PZJymjbPsxyPP
N+/qfSG9pl70klj2nTtMkYOS5su9tjYljV7rpo5Q/FidCD/x6BgJq4rcYUM58nGH/WNPNoOZ7BZe
Nyc8+AFhWBN3XuCicYKvKJqa9td9gbG/sKkmcGZAUJEF13ulBxZXtkalcj5tLL5rrW9sHXu/paBh
o16qB+IHlp8E5oLLVg3rWgcYS5PkUMqIwrJOTQZecdsOHPfwwi8/V7ma2cYisvIF5oVuEAaScN8r
k6JHpXQ/f9KD+ny5+Vd2Q/8w8AsOp5Qcric4y7TLDUoiYUWhYYYBoq+wjxYf4c/hBfRpQYmzdRSB
tXwnwl1Q8u63fdzwJrsBurr9UcoufHJ1WH72PPxvgLboqsj0D3we5jG5NZyP6mOI0X1mUe9tMVq3
UqRIc6l0y9hgJVUIu9P/hsCRinHMkNNIyJQtO9dRecS6/jTP6R/mWl/BeP6UYn/K6PQ8BWrLkXLl
fvMffr92XXgDwxXrhPp9aPnDAvDmLMqoj8zdIrLdwgW9IVIhxYSc3015JkNnqFW4PAA+3n/75u1q
4cLrsVzCGcbs6k2H3a/C89k5mfiwoG4KbPI+sib54PnWFgt5ZcqYYP2mSh2rVCQ4wfs1opMf2d5X
mW55Oqz2ohFQ0INox5wynOWymMPqKbP6vSRO5KSv7iz2fTs/T+UQgdJwuQVXwqR5j4q7kULieMdO
niP2tvWtJd6hTO9UtbF6rD3fCDG2qroUtWYLcgQPC29uO4WDCdwQ+2reuAxb6RHzCtS2ecsdtwRb
q7uvZjhp6h+Qf28Er5Wfb954NiVkOXlYowICLIdwEdEMY2/H+9lucklXNsD/pAPPTuxBWYEyCP/3
XD46XnHrVs8odtqN1ZVNdP66d9ujOfPgKqcxTRhSnmmIaqVfQbolUlj7gHO/vHt4IBuPFozNSY4b
+JChvnN6UF4Vozg5rtTr5WG69hJjq9DncGfqssBOPMu9gX4FN/rSb6MaLgg4qkEkZ4uNkLLW48ZG
j4KtPI0j0Il1+RaUKE4O8x2qYqPe2aogWBuwxhzHtSpIQIyKBNYDfzzBpniB5exI3evycv5f3cC7
HhHzlI1MzD5KI5sJFkNTe4MgnX9yFyfbXe4Pe4Xx5jNjYqMUye9JmbNTPcPq1wVcZeeIgZypJwPk
98KW0Jn64GMEc+gexwqOFGmbNeWOwSPzZC0gssyw4tgHy9lYlOjmpqvZcocK6gzM5IDmD4KBDO6i
2P3ObuHtO6Im4qQXicQZm9K7Gj4bseyV9zKmtXqkQdgeie6GL0qx9PPs9N2uEn3wGapC/0ZOPNiJ
CsLZpvecHRATcP+wip8+1Pe73g+yR1SfCFQh2SN00ZAsOPBVGKKphfvG1ARTHMKGHeWfsjjARGZ+
nVk/7rxQlrdcF8uNH4zTqaVWdfJTVt0yV/+PtmV6cCYQYrD/gddFhSJYxcPs57AEQLQVIgv+FGk1
H/1yaCH1IuKuTYEDFLkSx8a2YEbTpf1DnwKLUcyjOkzaFYD0hcsbKvrbQ+la8OsTPL+HsyAq9gaw
4KO0EuTB9lvY7okucKLMceQNH2Xzpvzwj9/WOkaNuA8ThyL8/2SfDmw3nrUMEl2FfYwS7uCnP/rt
oSFt/cacJXsb3Czf5QH81sKZPOaItlEpGjD5lrG/VX35WwQA1UD0Vd9QYbeJp7PXHnKyF56N42Gk
dg3U4DKDHMx+6JrkX+rFZ/eBx/mdYH3zuWBwe/FHFRxCWDJA4Lj8vjxGV+aZSXScoa7oU5yLgDbo
j+2ZnKB6+aSmauPybyVSmLRAzQjy7Oeo6rk5OMmFRiwayu8oa5p3hURt5VWfYZIDNUgTg9YlYHTC
esorFFZo+crBH7ru8ca+0Qd1uybeMCewBol69qnps0jP14ld/gGVh0qVUIIDJS1L9qm1qy8IFD8v
//CVc4XJ+PGBaC1ayuhJ1CD4Wg8OufLBxlpDO5EDRhZ2ST7RV7+YHxR8Ay7/5pUh+Rf28C4yF7Vq
9YwqdpzmYA8n4MZo7/wtberaw411BabtXgdR1pyATQQvkArnaTfqwms4uQHx/0H3LJWtIP8CINVr
QMHKaRDXDvbVKSutjbG4NqOMNaWeoQpuusY/6RTkce7nb541IIs9tTvfEhs73pVxYxJ6hJ8WE/UB
iebdN6d9UcPb5b5de27w331Qhyo6UcPpPQErs38kwFQUkbPU+caoXNkBmWQFFJ1PFvXQuyPHPOVT
bA+fefHcwlTedTbuSFfeYfJ5Mr/N4eBFQc7xobONvICDUEb7AUJn7EpZMM8PNumkji632MqANfHm
qKJMmTdT74Si8JOW/sHOZCSWcSNwrn3N+bXvJpstOyeV8FvC0bSQJ66oOAg4RAGR7HexW/EQPk99
+XzdtxhBgzTEA5LYnZMpvAcRBTadT2G3bDTUiijuH7B5kXdqSBc8feHcO4mRTbdW6rCTRoYlTksv
PUzwgYIfTPHilJk6oha9jsEUd2+nPG33lz9x5bBtEp8HWg5DDUvNBArL8nkaRrpPwW07tDQETh9i
XjnBqdSFodpN23X2xn58bVoZF2CEWNAtTWpOFErtquGxL+qNVl0ZfiZNZJgCr1l6CeshCXceUf0P
x/obksE7+HJ7rT3/PC7fjb/KXnwvrVsAXjN21/T9oanLJmIN+XP5+SstY9LXK79NXQrDLRjzeXCD
8N6ChW2c2td++vn/7346jAO55jSoE2nLiLk8ChwZaf/TdT/cmCtae7qFHBJXs9Z8i6KnIygiGxFs
ZQXxjNNbTWsvsGSxJJl6Gfw/ICZEQfvNV1vXP2tt7vy3YTobCWuhPHY6m9/dt6By3DZqyo+XG2Yl
YpmAjDmE0BG71jpxuhJOvrWbKBo+jGV73+dkl4lui5Cw1r/GQjsMQVqHFvoX5QOAItqRxs0vXPs2
Iu9KL5gkjCl0ZMM5X5KO5DsL8JxU2bHou0i5WyW5K1/gGqut8MLer9SkE1qQ8RZspvmJL7DC4iET
Py73xvlR/6a9fZP0kLa9TSnN50T74tAUoCCUjf8DgnbcHC/8c+hPB6Wn68KcqaWts4o0dWU3iVU1
Uapuib/xFWt9YUzluU0pDz0ACe3a+V8+Ia092DDsLIVzV/XT1vXzyrwwtXt9CgOUUYfeiYz8iwzm
F9HMG9Hir27uo34w5jRgVXRO6xopkNB2n+vWC2/8OsztaAotXCrm3jhEYybUFPs6V0UMByEUMsKp
6piJmRxHDzivvQXBXHFU4ah/9ZCfIdcf8oJHY+2QWFRBcVDAs985bV+cLNsan3CVYb/aZ++kMpTh
nxyUiixiDmo+gYYa4OJOi/aBDERGqJubfhZ9CgREWMgvl8fe2vA24gysG0TQ8gpny6U7OVkz7QKZ
PqPC9eW65xurajg4epJl0SY9XKn7kf4gc3esuv7z5cevDTojvuTDjBIEIAwTL+W3eZfdAEFwyEl/
6JZiY8KszE5TQhhkGRTS8KFM/HDOb7zFfQYk/JinuLKzhuDZCcubYmi3UpUrH2SKCnMYtLZIT7aA
nfN47nBTy38L/7VVG4N8pb9NZeGYejDrTgc4/NgafjWBy98yl9OTFtTZaLCVxcWkTfAQUESUJGFN
OZfdEiRk9FszveSogOm3zMHWmskINo3mS5EVjY0DRPDQnJufdPRmkeIuQ9JnY3VZYUH4f///bneS
VXPlzryWScPj6VA8OCdgA2O+I1ZkxV4EP+N+Z92j+v+QRqfnbJc+1G/+fuv1K6HOJFF4+Tw5UK0A
zAl3vNd2zN2DEpktNnaNa01ozHwWjl1AVCWSqv3VwZ1+cR+nlO+8rVzA2s83Zr5tZzaMNiBkAPYl
DgN2x2b/5vKsX3u0MetHaNBLdyidhNjymabkya/Zxs5opVVMDWIpCpsvHI92fHVbg4MGoBpYC3Xa
kgi4QbExtFbmiG3sKjoxU7sLJtzPZDCsDeAa/q2ovQw8NeLHnVNUWUTtaiv9vvZR51/xbhxXTqpk
VcNXw19wLhCPvfjuAhbcVRvKsLXnn///7vleVjayGaDby63DsmC9rL56SHs7w0bQ+htrP1iZTRJG
Bw/CJrVcLyGxFwev4z20iPXLEH1aTnJfxfLG+YaklvdMDvXOurW+qbf2rf5JPk9lxHbsFru1jX5b
CZ8mJyPQbbVkWe4ljgyPqOdbdmHfPKdUXOcM45sAiKVXnE6z7ybCDpeHPutK3JXb80ZHrUycv8f+
dx3FZy9slcrQjrZ7qwX/0bLrXEZ8U6EapH1nN1nlJXLsyoPIdPOMNASukC5P+bWGN6Y8hjAowx6F
JctkHQOiS+TECxGlw5aCd6VpTO0p9g6uNTL0rI/iAymnuyoNN2LKym831Xo1hRO7XhQsk+z2ODT3
S5DGuN7aGJJrP9yY3MTKrDFMXTdpufoliY8q4/RwVaMTY14Ld6RUOy1NZpgs8P6tDmAogiKo655u
rOEFJCqTV/cOrEu6+8Fne0UA6QNoZdlo97WWOf//3Wj34UNXwOHJBZw/vxWiw4atDrea/dy8H4Qk
EwmD6lGHEmKzZDoXrPApT9o2fXCqOofniiNjNrGN9M/aZxgL9Vgi6wfPT5pQweq4GOCPnHFvY7O2
NjaNVTqcxt5GpkonlfMFtucg5+BmdL7yfG5KkkEwdDKPeCrp9Pi/gCxf/dz7WqbhQwrX3Y1h9PHi
Q00MRBYyGdrw9UyUGyxPPuuAfekr1KT5YBTJyhP7y8P143MA/aukeTeaYH/eImqO0Cg74n8MUsXT
Ms8NJEiebHY6rMkLGfxeR4Wc01+XX/nxp3mmKAQGk5VvVyVY0J7eN6UCf4bO5c4P8zur3DQR/7u2
/DuUqQm74LImaZ77LLHkhE2Px6tDnyFB3cME5DB5liejWgBDNU9dd6BcjAfmlv2N1TF105HK+RYU
OOde/uSPBzs1QRT+VC0gW4Zu0jdzCAS9rexvIH2x6wxHqAmbaGXepOK8TKHo996Fh2pJb4dlKwv5
cVCgpoR14WyWISt10tDqGM6vOcBq2P4eyuAP2zIv/nhQgMTx36imU6vxvf68BREMSLjblNY3DhyG
bVRiXNcH7n/fwDWD4iCEsVDRZCiFLwF09rtm4+L071bpo9FmhLMpF2zOBsQE4lZDrFKWf86HRn6C
sbH1MBRL1Ud1Pi53sCttbgu3kQdkPLrjoq3uy+iMroyGrErjjC/i23Xfa8RAVlV5iwDiJZnm93q0
PgfLcuWjjW3L7FHcy1fSSbhg2X0jdI4Lvry4amWA8uS/HWWlMFDu4dCd8FzPN6oAKUilLX263Cwf
Lw3UhBQUHmee6jCYx+HHYj2ieiWatnT0a882Ni1OMacep4WGiFQemjmP7LM/U/Z2+ZevTBETTMCb
BvdCHFNEDiLKyV051kcMosji11nl4Aj435afmD/UE7e8hJfB7QiblGgqvW92a2/dc66sNqbgtM7b
kuZDeEYLCx2Ruv9meXyHsiUspVYfVW5O8cpiY21b6w5jxuM87ThNireVIajwQJPvZc5g925dV6dO
zSp9Bq1QyTq01zhWUGaN7d5xuz6y+fQUTtW4EbjWPsOYyGnFy3bIfC/xzpu9tgyevEajXm2+KltF
zWr7ztH92Lv4CuwFooLDE7Rso3zeSlOvrH2mwHQSkwUTgKFJmr556+fhSzO4W/mklcwuNfcSMGAb
Fe0Q5Caq94Dw4CKgTF/9HB4fAcrsdAvFWQWZcRuIH8BOP5Bi+s7L9LrNPjXVp3CuYS4CGKYkLlW+
EuB5ThYU83u78eaN3l+Z9aY54RkOCg02TitT6D8DVIUlER50BdV+jPTc6+XQstZHxsRvFG9bd8Ha
GIzFjQSdWdEtWNXa7zcWdhv2CfUiFztpMi9qxocpYDFx/6R6S6ewElOYMcsbNtOyGeHltzjDc7OU
sXD9o1b1Y1sBHuBBjN1lGxcNKzPR9CYEMsOZU0iyk8pG+MJlPNJzyCoe3Kq7bu0ztaeTQvVVWGo/
8bEHr9mLm288eK0bjCVbZmkztrQi0L9wFsmwab5kEDED8inLQ1DVW/KglSYyVX02G9yQC3wAhx+S
W91n+LO4G7usla42tXxzT4kbcLgALx42b/ouDTmYWjqiqYjs9pmIend5PqwUElDTIDIve54WGVLJ
Ch4jx7R3g1PqVu2XcSTkxkVlQb4ndVqX0cyoigvRc74LKpFvXWOv/ADPjCy+7xVVQCUy5Trqw5jM
AFNAJBmhXg4KVNeKgq0Y9vHc98wA0yNpXgCmNCZlgOKibP4E95yN+fLxo6l/HozvDpd+j9QYDeED
KXvnxzTxHxIgqss9tDKeTfliDZhpDSyUn7SkPM4SoLLPTHz2yi0jurWffv7/u59uaT7pdMTzGang
StBBDbixeV6bIUa8Uo4bkKLiTmI3RR0vyPQfUBjuxHDz2IIyrc0T4zCCW2U1ZWDCJkXQ7Fz3U+q0
X4j9Sfbu0QKE9dqdialptAUweJoFNGmCMeY23Gv0LzZm+8td/Dc7+MGZynQanEQ3YbuLVanbuc/O
yY/rU//CfoZJd9vv6ac59vbVnj8XT8E38hze2yd1V97wJ/69+Q5/hy1V5cpIMAWPdZOpupBQ9VHS
fKnZcK9mZ2NtX3v0uf/eDTKoKFMmUZ6UEKd/coV6DYQdbzTeyqHdFCOqWpFmECj5gP+jjmkF505w
hIdnXQE253uwcotZCW/Yph2Xx4ahcrzsR/dr7vjycfaxGYc6OAPLuPNOVgsjBQXO8XdrwcVmWPFi
iioPNgGzP7g/8kGPh14S8ljXkLnrQfCjJTIW0zELdnbB1VUHINR4/Le57CbsHAIUQjLXvyxfHZaQ
73rrJwyCN/rj46DimT7KHJagLczgoUJs74cy3Es63XJQO6yvlzvl4+dTU7E5TkRoDZpVssidY0U4
ikJD+S2ftowt18aT0UDdMA2LPyINbufeo91AEarr58s/fe3R5/+/G6ojVCEaF2JI2y4u2zdiDo7O
0iyHy09faxgjJsIEcASS0pfwyCavMmU3+ZwX0VBOT11Nv19+x0cTgoXU1CsuIG/xzoUPbNV7sd83
kbZZVNVhNBAVw4tuY+J91FDn15xf/76hGr8L66pr8Cnym8XA9iBbNdlrjz633rtHpwoFSZZoVAJ3
k7ehTw+l3W50wEeL0vlXGyNnbiwuaQgHCtos3R732+Tou/bYRK1q0yvOmed3GENI+z5hqUXqhHg0
zuGZHeB+DASRKxveGEOdwzBmXCx6/ewel9DZKV+9XB46aw1vrKd5m4owrLMxCWSrYsS75iUIr2KC
ntvFON93VDiq7KsxAb4g9tp2f4axImpGhb4GRXZ+hbH7712PUFrnNczymj0b4NeuK7KVxFxpHVOu
mMH5W1l5VSfD/OyiXgLJ2I14vPZkY31URR3C1ahQ5/rk3ykKJSeg2vJp6/ZgZdCbCsV5ZHbfk2BI
XNqK+xF2ml/SvkoT3flbwKG1VxhTtlcD0y48jpJ0yN4IbMZHTLVIDdVWyfNaExkTN6Qp1nM75Ql4
zHd5OnzBCvbrqlFvihLhQT+mFsvHZPQ9FBzXsdyKNms/2piqVTZMVokyISAlncjKpqj1r4sx/8AD
J4sNQT8g8Xe+6J9bkA3CF5a5+8tNstadxlRFrTdrRk4wYobupiXpC3ecXT5vs6kRyc0dL+apiQy0
URrkt/BlAPuw3nP/dzWR4wIZmFWUEWdbh8uVrzC1f34rJchEo0osrR4Gy7uBO8+3SmY3VzWSKfYj
pIY4XXg6Ke0pGgrnphpOrNVXPt1YX1WBXFrOO8SErtU7bks3UpV9Z3G1dfRbax5jzra67xtXLtn5
gPYjL/2kIeVPFNs+X26e82M+6GPTTUoO4EINLT6gT4tHS0JLMvrWvesFJ1YOXy6/Y2WC/SvxS2vO
JjhW5e6dZzVHZ/I3NgoruyhTvge0UY9rdTx5svvnoSQHiEA+99lyTLGY62bT3+6c7PmolYwlF3jT
Lh0tG6A2x/2Tz8WtABgtctziUfbsOA51g2sRHzD0IK82NhBr/W5M7qmjPUyqpiHpsPDEY4H3pQOw
wmMut5bKD/1cMMFN2GBljX41LrKHb+bYPpWwJzxlyLnUu3CQKXz8eiwO6mkiBew9A1aSJuqs8y5J
DGc0NPxi7TglRYOyQZ+SPUdFOkwmhSr8uJh48zhTKX5mhKg5Lt3Fwi0R+Gb7muVSxkFNr4zfJvut
BfKLEHitJqEzfsGF5SOfs8+XR+5KJ5jaCicowkBAGQLRnfPJS4NbMbAn+LztLj/+vHP4d1h5pqxi
YWXY84W0iUOG19wNE5FC3iqZilALNMSuV/5yNL/GPRi9bcou+9kP/Rnu3QmAszMqaeyXNsXNJZmW
/eXPWZnnpuBygYbOCSVeUHhPrDnV5RV3VOcfbgRZ6k4FaIxU4079rih/qfKun39d/skr4c+kktuM
SPDXpExY6bQdkhmV1UU9sWoKCgVt7tMaFITLr1prnfMYe3deylzi0pnNOoERVCSmhwVWR9c9+fzG
d08OtE0zYePJXfOdyv+5W0vn2i82Nka+sHIydhj9i9Ptc13cu9rfuDtfa3cjoFoh8ohzgNw0X6Y8
SsPqVTbdkRb5sCvEll/Vyuw15ZI51azTZZWeJJljxyaPYZYdnCzfuPRdax7jGGM3Y915RVZiR6qK
GzbO7Z1Qy5Yy/UMmB0a9KZYs3LAB0UJhutaK3Vj5AoV0QLxYygo7jbnGndiSKqjkAys/yAneCcrR
dcz9ikXjgIpx1S7jt5GOJUoQbDBWUpfryAKsL2LQc+885baPoce34EMrzWEqMPOiQx3XAgNM0rft
a1mF5f0wlPLr5TG+MmCIEQOaHF4mosiGU8hpF2ddlt1a4zLscgZdAEWxy0YMW3vP+f/v5pINz65a
4g4MJ5ilijzG7/MifJ2rzt1ZU7iFmlt7ixkLBJ849qQ6gWf4wH7XMCIvxK3jbZw71rri/P93HzEC
jD4IC0On734X5c+w3qLdrD3YiAieTcYwc/Fg3LJjExAvbnbddsfkJU4wNBRLtyAgBPVLSew+Lv3s
c5nS18vj5+Nf7pn6u6Wxlr/HJRhnPNqAmsGhZuNa4OMo45lqunxZaCn6ASzSHizJMiqbIpL1NSIY
Fnqmlg7bvkl1pB0THQR7CSKkS5wdrpWuaxVjHAY2y6RF8Nsr7kajdT/pLZ3FxyPcMxV0YQt34HkZ
28TKgohYc7yMYq/Kz1O9tZ6utbsxFgfogGiPnF7i926k8zu7qyI2b2w51oaLsT6JjMywGIJdN7EV
1CePZHi73OIfn1g809BHgvvWwZUGmExLn/q8jW3pRNDxQ0q1W0S6MSbXfr6xNIXQ1luuj4sHVrLn
vkSZiKyfLn/AX1+CDzatpiAucAcUH8xIo4JpVHqRGG0SqabwdpPs/d2s7Gynm4HtRr/BXUHQeAq6
MMffVZkod7nT2TeANPaJg/ronaXDdN/hLAVZbNc/83yRwEX1EhZWsEpBvjB4oHRuQT9pAczURVcf
Up4HiJT2+MDKLjw6rij2rM68HUcZaZQW9s/L37kygE31GYHob8l9LGfg6dVxk+cHFFp/oXnjIN+N
69DLb1npKFOCxlpP8HNQPbXpMwVjRIxbAtMPFceIHCbckFWuFS7AYJ5A0c1/odhpzuLqd/8NVa+w
CfjmtnFaR8VGa619h/PfFQc36eCNtniZhHFJbT+nWxTmtW4wjsGl04O90kIDlJbw68wjSesoBR2r
nvTuchd8fLb3TMFZ0JZgQDouT1if/eo1uUtV9hmI5jIuerLPsuq2F9Z9y9ONCbTSVKYCTfIRxIQC
c9Obv3ni1p62Qu5KQDTVZ+3sSjVSxKwu6MK960An37n9dFt37taNwUpvmDoQMXIpvDyokpovJ03r
JRnE1P+hAVf3uNHvNrpkrYnOr3+3f0l1vpDAn9pkqMv9pMOzY/Lny7298gWm4LYJB+oGcIFLaNC4
EQ/7577rv4AdvtdTd9XBwDPprZIHZO5RrJVYtPxE+/SH5eitUpKVTjZlt3OPZRUIA51MAcjq0qu8
/Sy5FYMqrGG9CsezNMrLtI1BGlN7ePWxwwz8PmSUKUDJEH3nx7Lv1Qvk7c0dKws7qhcRRG1ekL0c
dfZUu1TAoNGhu0wLdUCriIOa5wDKDdUliMPZ4Vwa/5Jx1Z9gytTbkSXBVozzyW7+eKpxnhch9cFB
3Y6OdOlPj006t3utJmcfYvGIobndOfUbYVZaHzX32a5eWvKglS1vO6Lyg9e41ZPdZ+RPnWXD2wgw
G5wA5/bYdwuwE6ET3GDfAu5v6dLHvBdIX+RwOd7a5K7cypiJ/c5GMs2xMUGh9R6OWT4NL5PIZ8CH
cTK104bD83AAr9KBR+K1E+s8E96NeGVlvpOCZ5BMcqwip7WRF5Z3zjL9yJS+blia0kTd60rqFluy
2S5/Fnb+vyVzt1ablW2NqUXE6jz7bbfwBLxKFddW+6VZKjgNsC+jGu7dXl+5YJqSRJKHVs36WSXe
lO1G3Am1Abluz2dCMIcut5gqHBxBRrEb7G9kC263ssKYKkTnLGpZHGtIan8OfnO3Lw66oDzRqGX5
1CnYeslytqIy8POdcjPncDnUrYQKU5+ovcLxK44jldU5+7mvDxkDRXLcUuqtbTBMVaKe/dkvCNJP
6aDbLO4UPLRBaAzuJw+8hiFt2l1H7OKQBap5WNyUPcJ/Ij1yp6ifZtSCPlQt3TKt/7DiBbsdep7M
7yZQyVETxClDvt1VYq9ru7pv7LqLPd8eb+bG83cWovG+U6zbd9zl+7Gw7Bs6guzo2kp+z1pW7+sx
rTbWmZUgYrKLuDyDWfoKYsNK9ZE34JbC950btyLY8ud9FatAvOm2/3W5r+2/9mcfbMtNdWMtnAye
q+fsdCfzxAJN6m4JXAXakxDLV0J6fSvyUL2RThcvk8P8HwFnAE+682LZu3N5RdwuNWxhXQ5JjVsM
XUJSJW4Hp04fVViRHSEuO/CRix9OzvR90OVsXyxn1r9PvPwxtcfyYDlh/XPQg1vGCFzFXUWtNsqG
pXwsh9m680RuHyyLTZ+IatmnuQnZz2ke1LGdanioTLYV7OjQzt/yNpSfhq6gKJBrx9fUL4qXnI3F
L3uq8/tG6iDOekGOxbxkIuI2L+8oEG3PXteAn6pE9+IPyBNnGBW/g9ZhMK+VdvUZaY4pHutlglwa
rC2bM/dxWArYNOKuLLJ9u3ygZ1ekXGVQ73YKV2lNU1ZH3D7DorntHqAlnl6LZrT3I/HZN+01yHt4
7XCAL6S1U4OG2LvOxY4Je/i6FJRGnAd2TAWhILOy9lSSuolxChzivkCtoc1nrJ8u3ATHHNbaLKXO
Mfd9mN62/nA3EppG9Yi2rxuQ1/M8IHFNwGGwhsz6CVZNHocUujin9FAoMWe58xqo3jqMddm9sI46
IFyTPM58CH8w8J2bjNhZPFQQCeupzF9UtXD4ndXzJ9wIetAG2c2nynV1DF/b9ui2bruDZ3y6l12G
W3HuAkPvWimN+QwHicYN/0jUnB5TkGp3vt/Ju6YNxyNDadsTpCn865Kp7Bev/4+zK1muk+e2T0SV
kOg0hdNy3MVO7CQTKnYSQKKVEN3T33W+UX6uMVWeuspwULO1tfdqaBuWYoBGSWbkZ7CK2O5LAcWB
MabahqNMl5H8hrotu3UT+vbxZloJnEtslm13NlUGVz9O63vcannYVDm08ILPdWKcJSrLJ3A06MuR
x7y6L4r7rP4TTBsJ4kp+u9SRI5XH6m6quouY6x2on2ENR8ERwNuB/fp4dFaS8yU4C1LUjuvBffYy
TwbIoFxwkLNmdyNuro39IhHqc6ytBtkXOB9kBzECUH/BUAU89OMfv+LL4iyBqLM/Daqr9HiBerUd
1xUMBdq5n14DmqoI947fRCpnR1M+XJgDZmlSafCQPBxfEZVmuklNEuxSwEX2Xto4p49/1XtDihL+
EolZVh58LFgwXuB9g4vbHJd6S+vivfG8Pvr693/OxaRNRgIbgAC2uy9e2sdD932oPkdsd9zFZBnP
x+Mhb3eZquYMW6D80GXNt8SjbCOFeW81X3/9osYHvQjtSNx4gDH04LP3x5v1bvDfWliMfzzya8ND
/3d4XGOZOmOCXSzqPeAidfEoXIaoJfcfP/+9NOD6AYvyhS7cQUFoHHr6kC39UlOWzjCZoBW8vQAD
alhRPhV+mv/KiwEG2B+/871c/PrORfFvSv3UsXWfX0jafKv5LHeqNEetu+9+nSahx5qNOLnyomUQ
xrlncxiUw0yI347wMapTqD+A/GJmL+ySLR/KlSFcRmOI38+wP+TikhZQhgkrPiYvml8V3KZC2zdw
Fx9uEsLYDzNMzkaNZmVZLAN06hMiVJJMl5IJCO+Ph0w/paP++vEErT39utr/2ZNiLthVoH2GDAo/
9WN3ZonZUZttmCWtPf76938ebwnZuL0OfBgBFTvZHLmA7HKzEZ9XQtX/g81CaRepg+fHipsvlRzv
vDbfuJ+u2M84y5y5Hm0leprDrYGN96nM7kgx3LHcOtoTrAU6/tTV6s6C3zZUoiznqMwWlHklzDiL
KFDlqaLal/MFt2N2Z/V1d56N7+xUzuhJC/QEN7bmCkPUWaJrHePPtkA1JQYWnh2T2dJn1VvVOSvK
50TKEh4BzRAO00RPgQVUUc0CEPZdz4kmCTPWrZ9xDT/LywJCxBKBS4OurmooO15GMt3UcPbhVYP9
lRwkZCq+1w7eV+HHxd0s80NCRXLu3FFvnMErG3qJ0J2kaoBAQVBvehaJ8ZkRjjrREPf61Yh7WOJt
fOXKPliqiqYoSfemgnBpqQEdF6KDTuQId58W989PbeQlZJdBa8CZ9RjEzvizJ78rlIN8tLo+9/BF
lDDKE43OmiCW/Tff4wAwuJBIKz6XcrBFkCC2kLpITQB19umBdfzsVlvIhbX5XWQFnYbhim/gcjZL
Ck2RrsumWJrGjricqldIX5KftEL3y6Nzu8VLXjmKlqbgTslJO6c0iGfUujX5KaZnrv9a6s3P/3xu
OhYxwu9p5ZG092OT9vldZalIWL6MwJrZSnZWQuvSCDwA+oV7fIa7kmLPHguibuo32CbvIv2w4ZdQ
XoKwQ8sWK5VYzbhDLRY+NaxVMA/p/0gfJoAWmh1RAErQziFecYSPsg173XqOXTQqb0fVvoydN6IV
4kL5jScknPSAWySZzR4omP5FDTnfd0aSE5Rjp5CXPq6Mnxr5JUAYpUWezz2WaunOT9aYXBzBT5md
up98/nUd/3NeMt9LO6Cc4IxuUlxoMr2Hwc6BuDLf2skr58tSEFSj6uT7spzgkN5YP8su+z2BBvdo
MXB+Wt6av/U0lUdPBrfUCeDMXrbiZoQmReQqwn9UsLoDM9MnkPYs5EMScPozASE01CzpbwcvUb9q
uKmdeYAiYm73GSBCjIW0Kt6cpBZ7OHUVuPTj8m5Pk/1MQdyBTfs0/TXIO44y4P0XV2XNXtn5fPZ6
Vx7acfCjBiDQEyjmMKGzvVcAzOTRrZL6lHARyHC8doCnnmYqbBQeTSkb55AH9YPn1HHGhy/uUJOH
Uk1zOLFC/Kr7ZpJopQfNLcyRbAgwGv4Z6gRW91INlRd0qAOvrS8D+TESG8gnyK6Ofz9efivbcomQ
7uXUJihoqwtrTAsvADWlMTOz+vq5xy+i5cCrnPfp4MUDJtMbxzduWZ/85ex/F7YfSEDFspRerKDt
Dsns0Z2n8mYDwrei3OrQRUT0EgA+CQngkcHLnQ/ye9bau655kjBq1H4QiqE9D84ccxvhQhY9/AIf
9TTtRTVH8Ko8ThM55E1wytx2P3HnLrXkUc7D/YiDrgUqEK5RnxvixSUsdxs78MCvia0KyiuTN5+t
tvhcCrCEUEMZOx2tHmYOQ6Uhxi3Dznxz23Ercryfpy0hux3wuaLJ4MuFVCm/NU4KOXGXyjhRZS8/
F/6WqN0sMb1XJeD2S3ka5i+FHZfs9eOBXzmVl8DdnBtXiOujW22iZHglvYh62Di69s+Kf6aYhs2/
hPBCcaXr6Ui82BbVnd8Vz6q3j0OxJVa7sv2Xsqg+9d2hdSpcBesaYtEKorHzFhho7dmLvd/Dba9G
nodCtLlqKP1qio0Vvzbwi51fOCRRdoMuWe2QXZGXJ4N+JeGPRAMMyj4nQOIslU6h7jabAc3di+QB
jJpfevFX+fuPl479X7f8nTvKEr2LoAv93gBVWGqBQNAQT51AwRjsaIRsq7VzRd/xnePP4CtDwI7u
GMSCTkUvm5/cmbMLy8/zONNjC7Xys4KQ8QMIEIUXGXYtJ4EpDl/ZxEqvsBjRuIecga8ceoWWTcgr
B5RyMXBxHGgT/EiI+j5ksvqbg5W3T0kNuTQlIUsbWMMBx2dw73mtjcqKA5G1EHYbzXcw4crId2ih
d1OS0fEGRioa8vIj+KzGYu6TTNGSonkxhpMhxY12RX6Bfo84Mbfy923rDH9l6otffZaVR99VYt97
k8C5LelRjmp88m3LHSKWJOIrb1OTf5nslELVvi7zOTRuWl56S3rnmmTukaVJ+jToSZ/FYCdx4fX+
wUqycZfIsjoXpqgOaLXksHaldgTjY3Oyr5ABlkso/9YCCumFo82xK41zrDsL3RQUwz2J6wjlXTQM
ib7p6pLn0eDWzq5mVn1JgT/5Oqkui9AUCYaYJMI7WQDAv1icB/tk6KZHaei051Uf3PmV1z3VVVYe
nNQP9i3rHRLCMgMWKwAgOA+is72vUgn31ulzKPbgd59k0LNvCZ2HJvIn7bHQgtLVa1GOM6S75rqD
JIq4zdC5Aq5BlyCgi+rQVa5/D4kmfSr7xAkbRKcg1JpWl2RW4x6zbd2MTkDZHhYE4s6HAeAtbP/q
P6bQdX6qFUziQjurYN7q+159Kkafx3Qs6EMbtMK+4kmaHsbOOt3b/sTSfTmV4LqQREcWrvMv7aAA
2LYdYuBdCFe+W/TLmLcv6hJK91Ob9TB4FBbE2gDpbiuYcuEK0OxGM4wXFkzD0W7afm97bvMEzXL3
zW0mtJ+SZMij3gvqErA5nn9T2QTbmxYu6l8arnEfRYXBMmEBj78n2Ovq/VBPoZeWamewSneN/2Q5
OGsZt5w3QD7ax6JD15YUdfMskvyrhJz9kbZT5Z69rK/iOsjGKJ1ndLDSUp9kPbzMFDqguwCffQ9K
9QBRmNkjXdSqaxcyJeADScOGHLrnUK/43NG4BIQ7qKFNOWmDGOaJBq3L4Fgw+s2FCfnnzsWlMK92
ZpOkurPh3zLgPoSrQarUPqHoR3wc4lZuBWRxBZ/aghont9y4SdGjgXW6ivOqcEPh+8MpSLJko662
csqQxSlTQuq6TedBXMbCpK+SUqsMoTpKNyZi7fGLsyYndtCOOazSWkdSuG6K6iwhSr/73CDR/81h
LRc+ZXMPY8DSPnp1HqVIgah9N/afc89xluyxbGKV60r4lsnqgaLQ1/JbsXXtvs7kO0fYkj42N20x
0AAEFEZ88wASQfIHwtEESraZu5HjrxRbloq5NB1HCFSqGToDtr0TY/Bdw1o31HZ2krZ1r4b0WHj6
c2nFkpLChV0AydDDL9v97qFNrib4yuXI6VoNK6wtCsbaglrcx8uMudk8tajbVXyOa5PIfVeP3a+P
F9T7A8aWnDtWpSg+Edz2qTsPUAvPeCiyvthVNh/2uORYgAZ0oMjwUm2wMd7f52xJPWB+7ftu6aGa
2pqbyoZgALf12xDosy68jXRp7R3XRPCfGobxZZdYGhWGrBiaZ5cOE3CNtXV2feHuWZZZG4SBFSUw
tuQj4JxFqVq7+QXqh8mRlU23V77PIpXbOUayGPJvXPj8UifVfCzrJN33Sg2PH8/d+yuDLaV/K3sY
kyEwSUxrXMQHjGTC0W/6+OHvobQCwpaMBQq97xLWwjjPk6AOEwVy0UDUb8KTqA/wSmSbYqC3Ik/+
fPzC96MD44vAWWcVLG8YtNyYHzQn2xtOFghqIcnsLTnttTcsgiftBk4GOBTHA3V2CWqXuK3ukTF+
AmtwHbHFvdpX7cSHBiM2Ev29s7yDn1c3RqdPLDAbQoFrk7LoZXrCrdPA9ZO4Bw/m2DN5bGl+9poS
cpNOtbMtXx0yMT4kbKt6vTJmS3pDpppCsIElMdByt7YYj5Cz3gtFNkLoyhJe4o9R48hzT6Efr/xu
r2frh6f4j0+tpyXs2JFq7rWxeRwEL5OaIy/oAXU7fu7h18DzT4AZiQX2nU9QhM2LwzB5P1ibHoI+
38J1vosmxGJa8i0CAIndIscLRpbTCI0yca/BKNw5id2DOFST+wSQ7T0qmia2+kbtKl1aSAmIOpVX
KsnsjZ9hFl1/ynXu/vlWgFkF3MoxR7zNdlXVAISSTXdVWX7O050tqRmlvtbjGwbLzxYnaGOmJIKI
9VdNtmpzK9tmKQU8mFwIT+dBXDsZiKC2Z6JuoHdwTzjUDv0yAewYTdX0VFX898frY+1gCBbBwACD
ZesZrxyZnRzyTu+bmh2y1nsT6JFBdVM8G/DW6jz/Otafoj5fp2oRHxKbgK9pw7PeNtCdzrxhPPe5
KvYff9T7ZRS2pGqAWwrB91KDh4C+m7CyZ8+h321BjiUHVwfFgC3qxsrxvaRuaGbXIOcWCHNu8jch
yU8+lfdgpVwCi221UdY+ZpEiyG7wgxqidRfmSWBQhT+9Uei7RpYz2T/zpOpvZV2ql49Hzv4PkP3/
c180Uf53E4kWRn2lGdJLpq3iFTqMKj81nsfcaEBr35xFkYhocFhjxWAuON+YV+oXq7Hcc5CO+Y2b
2+UjrUchAB8diieHl6D5DWOfn0STD69oQogXcL+CJsxTN30JevAZ7Kx09g4QAnTXGSK/wOQAF2+o
4tw6bgMRZtMYM+wBUJQF/JOe8+LNpfWNJjMU+OHw+h2ENsyr66ufQYsyJcvH5s2eLdSyUWdIUL6Z
hHpOa8lPAgpWez1l/Y1pta5xGhH9lk9BB63fLI2UR+yD3xIgFUYZAHKjgwOZUvuFwlVg13JQczya
Z5dBZvZxtMZhRC7dWi/ukA8HanoS+j5wIZnlPiYlyjzoPxSnAOXf4exmFqirpOy7w6yK3xXQJDBM
tKzbPHPtaE4DkNXgbLgD08XsxTj+0EPCwF8bgIDuXR9/CugBNd/m61x6JWSq+4Y9YkjnP0DEOT9Y
5qsvw3TqA83ysHDTSUas8Z3fqhZ/Mg/uheHc+HTnNmVKwtlzUaxPlQTvlXjuc9Xr+gDRNhXDAm84
zL1CN4ZA8OMbmaBNHNISevoRmOgpAzARavGJ7P0wd7oxKgbXlCHY3c7etVh2D/4AsjBJtH8DlCmY
JBNMvPxMTGWocpgmR2QEjr4Jhori+9PxVzDMnoK+dpCcgGIoY4/09OQMCZTFgN7TJ8NF+c2ZS//F
NX17agt4h4dATQfnQtrOiU0BSgeo8pVp6DQYBKByeborZj29pVAziZuAZ8fCrbMf6G7DCC+bJqSG
dEjHLGoTawhd41pm30jIO9Q2Kb86ftaQEOi1+lb5EmrfZZDupcyLiOii33W8dV/R9wDDKUj7OVS+
E5zFnKKyhRJLEdVDPj8EvJyOqqb6DhKz9X1NBX0UTFgn1Xl5C1EGApSzU6RZvyuLurPvXJkWHeRW
CH36eCevJCxLNgwvWTOhva4vqGddpvYRzKANnNJa0Fscs23SijnLwP3k1AIsvfxD0cQMsvkE4/WN
2sR/TYz3otAix07KsZtqsPgvqcCgtbpsX6saRClDaRZTY6qHQmT1blB2l0S+2/T8kA5qeKVuDcME
S3ECQLzV0r+Zk6Zfi74SICAJTetd4Xvo3gZlDfz550Z6ka3PXE10qAINDGI/RbWseyAmtiA/K9fe
JW8mCwaOXTOCd0s6GlZtchny8j6bzdfC5cf5KoDeM737+EvWZnZxKlfDZJrczPoyw/PQ0iM4CKc8
u+vSemNeV5L0JaOGlMCmE2C0Y7iUndokbZGh671I+Rapf+ULltwZEVS5N3WtBvDUD2LL85s2aivh
AYlT1X8RnOXx46Fa+5LFqQyFuNTyYQl/GakHVQIn+JX44q7myeemYkkLqW0I23CY3KJJqw/jDL9T
77dKwUjZuhisxIel9HVHQf4o+7rGB0g3TObuuzZy44K5NjiLCOGr2a8y47SXbOqenCSJeepEpO83
erdrk7wIDmri3JoIt2MtJxNJHEqRO1VINZrbnuqt/uraWxbbOg90WUDAob7Us3f2Cf2S5ulD2es/
kk4bkXRtDha59wgfJ+Y5Dbmk/qBupiDN7+cxbTeW0Mpl4v8JX2ceGC1+0F6AC+p9L+z974YXe8c4
YV31B+jPH1LyydFa6lvLGZIAZR3MEAZqo8G+R+U3aPqoKjYKWP/BNt45EZZEsXLuym5swFpzjskx
P41PddzdD7f2SeysyI/6aI7oYbrxDsVJxe09OVVHc/L2W4W6lala8g8YcDw8mbGkezcPc+uvwzcg
XivLbMkh6JGiQITXtBeSm69pafKdPSaPbU/2ng8ayMfRau3XXzfqPzfjcc5MpduCXAyICqpLvrSO
f/740SsH1JJLMJq8llngcKAPSJS41Q7FsTCDGmfn/BihXiDV5wADbEkqICYorSZAFXvmPIahXQEx
GP01mdNfH3/J2kwsNnw7WI0cAh9o4ixqJg+dnftJN6GCONPHL1gJi0tSgWS6AQnMhYcNaJc8QXOx
7dtvtb8ljbw2y4vj2wLUa8hKNkOdyNzSVO4ZkvCPf/r1WHtn9y0pA44ou5TlQwWq3zNtb5rcuySk
jfj8dXb1xpFKr2HvvZcsGgjT6EE23ZYwyfCarz1UmLF4MvfWpn7yx+ZV9lWppPhiJwmPJsOvsjQW
2WuBvvskPHnfOkJdZt62N3UFUGRdj7DkZFmVHmfj9S10cqS766zqxWJkC4O4gn1nSyhxQItZJGlN
LkVlV5Hb5z3ST/QqeKisIQfXnfWQsHcxGYoE05OTMcATIQ1Jx1A3mdpYWSvTQxZL91rk86pqHmNZ
vpTtTck4cB0PzRyPVrbxipXdsey3OZaXm6mDgYHffu9wNyO53vcsLv0tu4mV3bHkbliE1rVVDnZs
OygTzCP0w6cDRFM3VvDK718S7CbB8qQlSKjqOQVa0vtLAwaD4vQbtdqNALL2BYsoK4XjkVrzGXKQ
6Ox7TXGuZrYvU7VlKLMSa5ckDtQk8omMHSh8mj5BsLPbWXPwHbPv7norfZyKeZcRssUSW3vbIs0K
3MKxkxaUEdit/dLpEM+EX3wIC+46VqJmk/xtbHL4OL6shK4lkwPYVFzNa8h7wNT92Qu623bcEqBe
m5VFkiVt2GIkuTCXStUEAMXqN00AYx2nLdGmlc23JGWQwEGhy1c0lslLWz5knn3mLQhPvTxAKOBz
J/iSfEFdyFrlDkyj2jy/s2caT6L9/fHYr/z+Jd9CAifUsgadVcG9FM5jnJ8ICGcvKETXh3H0DaBA
JHv7+GVrQZ5d9+c/qUgHxnLmGk3jsS+/dCUZbjIq2U0NYPWe+u1Uhyyg4qSYNcdZ6vaHvFV/nAFW
tYFDQNVOlQGnwgjYq1YEFGXPsDKC0gg7CReIdxdFup9cU3UL3sXnEB9sSbrom8AGfgH7rgWqBwIJ
0LpywJp7puPjx6Oyskb/n0i6mBrULD2kHqNzAh/ie+N3r9zTW5yUla28pFm4Y1JYfqtJnKMts4O5
JDwZU1nshd2UpwKC71GaBHAoGsYtKaC1L1qcSHZXZWlZDiROPfe284tjZyVfg3Trnm+vBIwl6aIK
yFXmzdhxVfaPYEV9pd24nyEfEQfwc4rBeciiQLgC4gled0ppU7zU3iAi5CEmtNig9rqytuhhax+7
TLxkV7uOSe0YZcvftMjvTZ+k0TiL3cfLY2WHLpkUWgKahzoW4MQlrHbUVyi8hoz3kSluEiTzH79k
5SOWguu1ECU0YDJy8bMKSjkPwP2HVB0/9/Drl/2z62UK21hIPuBwDxTdO1OfhFUA1fuO21tLYuWA
X5IJukKNTEnMPdxYQO/53dPzXIFD+zkGJVvyCRjgoH2faZC8O7uPOwkh16Lr+MYArU3xdZ3/M0BB
17nuMHMvZgH6y5yHSUJD9EnCQECST3xyjhdHegFJQZtJi8WJsKxnOMNV0diNydlkLjt9bqYXGz+l
LkQoUneMA+smKLOIsaOiW03+/8Dh71wR/jtV/hmmhA5FZaCZfMnmPM8hV86qR2GBMyu9bK4Ougra
13rg4xTC09aRURr0Hg1rlUAgpVZD/VxLn/5JNPF2M8nUX7+6Opg0hTNt1CnW+qlL7FjjGVMQWKXE
aLRHhQmyEHwOE+IcPSgyA4VuplMJHdkdLHhuAJDbuIa/v3vpEh41CO07SmRJXDY82BHa8BgLqgxT
McqNxbPyaXQJiOoTmbWACDqx4LR/Gl013jq1Hxy9yW1CiC6MkfRMsoMsN0wmsgoleMK8Xx8vq5V4
v+RroHfVllVdOnFa+SKkLR4O6dmN7PP9wWNLukaVF5UcQAmJeV89Mq0q3G6qW+bbzx//+JXQtKRq
jHNuLAISxaVq7itBj4B8R61R+wAwq8+9YRFfK+WAOJ57+YUX8vsMiFeU1/ww2hqEP0CkN8bpPwLI
O9tvydmYO5MkDaV2LDoV94W1g7zNEakpupGnipX3iYGcxE/mEVhhTfuJsF0nf05e9gJOUdiyn7jk
bVzn1qbs+vd/AoGAkhQFFGOMa2nLH8APsD1M0VQkA2fL7HTtFYuQPFMC6MBkgwjVFLEPPSQJ6xoe
bHzASsD/D0/zzwe0pZhoxxwW100XWt6fRLIwD+615wH3sUWvXfuERTAukNk3xcDh6yO6sQKZEM0E
x+NVuxtq0PE/Xnvvv4QuoVF0GpXljM4M0INiUR0kEA1smmQH+kX5uYVHlxgp1wNA6iq3cqlAzcgg
G1xOr7XwnG91WjtfQItFxLf45MyRje3920HPWAI5D+WmnehqlCGDOUVnwIIVURpZzHiRMNfbBClg
8tP67dbvvGZ8yw3i88BbDHgD3AfpmySPm0zyONeSohk/pv4+a3IdW4Biwauv9PIdGAz6t+f6yMT9
WXgbp8B7geb6evt/d0WTlVe8hErj1r1AIh4N8TME5kErKTaqQO/N9fUFi0w3gADSYK7XRKh8HgcF
WlKT+9+QzzmfSHXxgmUfgQ8SwmTUErEvBxeEVtc8d7Obn90+a3QoJoaGlVOIeWPtvnesXF93vTD9
swthDpMnIOzi2jv29y6dTiJINxCD723w66MXITnx7B4sOj+PCycf7lHZR0rnk4OsONlDMyiC0NPn
FAODZQ9hLMDa6WsrjyHjEzX6By3c85xs7e93xS+uX3JdDP8Mkun4QLMZi3qGlnk3z9+6ygpiNNJv
GyL+Elvu8yu8Q2bDTySYKqwU9CnLZMtC4N3Wz/X9i0CcZFniZAqyW9oxu6Z5YpD6UY45Wc5vC8Ki
En7tTg0cSTZHbpfHPamOV9/oubKB3dA7Cu9aA2P3doAMVA6fbb++Faq5y+byyTanns/f/ZxugMbX
FtQyw5ZWpaVr57En1V9YEETgurx+HGdXNre7iC1w4xQoRBR5nAS4R+X8piR6V3beC5TJ9x+/Ym3N
LuIHNJX91m4x075VHKR8bgJzhoAdSR6AfPzklluEEKDK6j6FrmJsz8mFDsM5b7ZEs/47PN8Jv8s2
BYpYhNoqwBApGgUe1NMChKmS7hr7B5y3QeH/Cj3PsBobMLTM3nIMmqNbzk8r87MUPJpIEQTdJGQs
s7k9qWruTiVE+g5NOtZxkldb6PCVJbYslLdTApFlqlNQLIYHuCjFfQYrp48XwEp8XzrfcSvrHMWZ
jP0508BlerCAwgtD7Xfp7nOvWKyxtNUqq1xRxLqkDYRyxte0h/lNsNVGQhvovXIXAsay1u/bqpZw
JGfAzdvZgRg93XdB2pwqAvWmsNUC8prQiSjfmkC36oS4358NaPHPsEECm4tbrPXDTnfs2fWt6lQ7
jfWNUZU9FSBRhiMN6L1r2XnkM5E8p9UMzCHEyNwbnVJ5VpWXXExFsmfXLWYrMqoObsACzJJQ2YN8
GbN2ZpGVgemsUmZDv5xUzR7ghUzDYJlCwMExDd9p6AtA6j2jJCoksXeV9IoMYD1afKkaXx9aRVnU
WW51Um5ShC3MMU4JoGohH4U6lM6cA4ZXZBNUNic3PfQV606VZ5GzBcjtCcmMs0tdcN8hX+AgnE7X
1E1PRVw1jvtEx6Y6goKoQWlMgngamPM2etS/NKWxXugEsb1jZ3fNWzc51gkU/faNJwZPbBoN+fVW
g23rWGPUgQIQUgewnBD6FNbO5jq5txPPH4DKqX0VFSLPoL8DDeXQc0eVh2VOnKe6tVpY049paNJO
7Saw4JDOQEVeow4eFRgvGUEbz/wenNz+ZVLTlZDcsPOvVtE2OzpPf+COBmEDVP7dRzPoYa9V04A3
ChbMAVrBYi8L6JC5nE+vWuV9mDeQ49hRwAvekjHtX7gYp58Qx7afKpQUHx23rg6JnfrfR8giFzuf
CLmrJ3AXm6EY37x8onVoVx3IrPU0tPfoQQJ+mRZk2ENwcdzZk5FwmjMDv59ly6Oiyq2IGMBkoxkI
/bsugYpYBNEjAuO2q7B2UUNEO08L75vLNMQ82VSc7WkcfhV2E9xAN2N6tvGkPSRW+j8W9Gf2tef1
kICRBgC3nn5jYO/D8MAdAIGFqMdz53PvgnlxHqEGyhvAW5Esh1q5c2QBhuJHZSZYbCuZnjH27tGu
KH9s9ej9hcwrJFadIishtupVb/PIrAfNifVaEMMfLN6V+NTWSn86Di2POnGgmwsNLNT1UCID3N8M
+S8IIingTZvAeYVtQjcceKft26kHWDQsC8H9HYzgKmjDBpAGP+YwgIosyVCpVTTvz4NbBY9dMrj4
Z3BrTdU1AGlazVXBPMHtCS4SzdFxpjyySx+2H75sw5R4AmLqAaTJwrZI8NDET/ZQw4K2bUnVU8kD
/wYlcPUgYK+msek8ae+5RcYi7LWlX0rZmb+uMig0wMlF7PypDOCCSN09tduiCCsyz6CwOFPs+9h1
eTpAKKOyfwhdVfddX/Yn6lbDd3C79UUUjnkAL709XJstD9rBqUQqHBKj3cLuPpiTQ8tRMoNbkXdL
e85iv3WgPtsz7zAabe7gJDOe4T8C/Vu7sNi56Hp7b9Oiea2RcYUFrfvH3q/YTWeVZWhL0YOh7AY/
kLTVh3xy9F0GYjQyoqAGRSODT2C/CxginYHoiw1qOMjP8Jc9yiaXR6djposyPfZ8x/qB3zaqSHb4
ye5LT+yntkmLECBweSg44wdLQXHXsFnccpmlVQT7d3OnusbaEzGYfV+TCRtxVAm46RCqh5VnD/fg
Shi5J+hanwMp6ck0Wf0Xjp/Oi06b+RTUbjGEuofyvKBVB59t4cMMA3z/bzr4P86ubElOXNt+ERFC
QoBegZyz5rKryi+ERzEjgQChr78r+8knw+WK66cT3acjKYS0tYc1hO0+tKDiJ1BBnna01u4wrVN7
pmKmYNzraoN8VWe8iYoDiqElC7kJXizEwVN/KaK0LHIvAE+wctkim3irAQk4xtEynVmwkueVA3AK
6d7wrVFLp9G9CzvoCxT1DoSsbgdd6jraqhqNlZDEIBMosHLVoOyWTR797DwV3YMmGnwNhqittpBX
r2uw3ebxzVZ++NBxv7r39NjtbDznL9AuX19yb43SARU67BhHhE8GXQEHq/TTHDT1Pp5WuTWSqE3u
j5Adj3oI7ZO1fA1x7m9mk0fZCJjj2YkOw5YGhmEd2A53RdQ2uD0ukv26l5lpQ3IetBfdUjXDuFmI
2n8wJJB7A6vb27iMbAJN5uHgdUGVuSV6NZBM/mpQ8C3JPMQhT9BtMU8tJG+qNA/skIXQvwszvFqQ
1ePSH6o5WB/gWxDga7JpC1g0fAy6vMy8mM+f5Ry0j1q25QNwpQCuCgZLNOX7JLGmxveY247e6rHM
H1XdDt/bNtJzooNy3DfRCvCvLrybeRnkgbYomUO2gK3uaDfsGxcA24bQLWFfGPW3Ud/zLwGt+MnH
8n1rZV2Cd7RgJzHrIVBx/xBb3m6IJO02hPw49n8E/0tTYSoM8X6TYgv1WyTB+Q8LIHywR3Y1PYyQ
bzrnyLS/yp5iZgYNBBTxY+n/pMPQPs9A3N/Cm0HfrdJjX1ZYy754cVk/j3nP1cZOUN9NQefxN9xc
7HXglUs+RyX6pICOslR7Trw0+Ty4rCTFssBML6qOo2Rip5q6vsl5sWztIvmhnku6IdBEP0COothx
qs0X23jBFkHSbijsiBIumyKt+q5NtR5U1hFZbXB3628T7shsNCsEM5DOwfV07Isd4J9hwqA3e6MD
BxvQytc/YuG8rQGha+cMxJ5MhPM0ayDoI58UGXCi0acConmZnXOVuZWUt6uzwOFBteS0VsuLDO30
zTBN0jlq5h/+7KBjVIwcIlisJa/LoMebYEIc8kHo9RJIAoBd0IGMINPcV+OXnnZsbwuKHo7rfXe2
60XvQ0CBux28/mwcFXcLTPVwEAYNZSANc598Aoi4G6AtmrQwFn0I4rBM0ZM0m7qoq18snPipnZv5
dohKfdusHkud8aH+4RF4SB9qVfM6EzaO19u2HMGB5WXw1bPhcB9zVm9JGXAg54boINegeQ64nPd1
kK/dPgo6+4BGDtvSYtQb5Fk1Uic0emAxSDPiw6Q68SU6UiB3T42A+leEVePwBoa4hoCEeplXD2Xo
oBY+91XTp4uOxI1WtX1aQooQzHzofg3G26NUQRVWu7bNxsAf/FT6JXWZ4Yt6nYO6g1rTGPUIALMW
d52hCIJ80FPKIUUkkrovyZcJDKhPuW/9dBZDf0cKG0Dtf+SeTERZ1Aotab/dVWaEHdDUVgR1PHXT
RYUcmiQcALy9CorUm8oUlyrNnA/B+AVOZGmvFr2Dnato0hkmCV1muqa3W6RG/Js3WP2ld3AXVQrD
kAQy1yDXjHDuvC/jstyADMEfpA7FV6tF89PmRZcVuAAxwUX7FXQZtr5Oo1hlokypXkQE5HKi6gEW
X1PdshZQw4nfYZ4oSMpJubx21RI/TUDCYBjM2aOEUgjLZDjSzSxn8Hggc3HXxFF8A02wpcvWapzv
cGP5SKOWiNxCq0SYzaKBSIjzQWyB5pjv48apn8FEOjQ6fOX/NBNMNdd87iGrPk7emdEwuHwXVoMo
syzy8ww1v50CX/DInKlfBCm6E/giVQa4pEVArotjrJUBd0b68CQOKnpqkD/z/RjA3SCJcgSKrJe+
f+exEfQd0UCtp/diKUCVQklLAzoWIAjBHhiXCfN2/QAj5QWmxiapQ75uyiEOPhlsE0yajhBwI3tc
deI1NtgeuJHrYDtV7fSl0aFNYfqCOd3cYB5I9fBdFpJ0GxPXMLZQuUvz2bhvpYNEQYKis8f9rzzx
LOY6WpOgXrq30vPCPFkhLHcz1Ly5MXytPjVduG7AbqKPcCxpjvUwNlPmqjnEXIyBf+Sqwv7koJPc
sjnuN2qwUNEpdpDGX8CHcc0dbqlxR7weAjqrCOtNZSKJvNvzHyDBYeFIEXhxMq2e3egon450jsaT
WEHQnTgNdpFD/lFqAdSrHfMssGv0eZmn9b6Ja3JfBsF8aMQis2Eqeda1Q3x3iaE30wrioPVUmVko
PJ/7hndd0vgQ5vFNjc/VRSzcrcigahy3KToR2EJteAGKlgvs9AteZ/S0th3Uf6Rav8P1Ux4j7Ic9
k4puy0Z0D02hlr0vwuZkxlhso7GaU+r5a1Y5F34tJYkeRtR5bUJqbz5Lkau0Z3LaWGtwIL2x1zTx
Y26mtFqJmxNWF8HRyr6/j4K+/Tn0M8qLrobyCVlmvW1CptMcYtYy87pi/BYskHh0kboIuzSsy0Be
Hz91VQP7cxUTDUrdgEMaSGc/B2vroC1biu/dFF8qxkDVjxUn3S3v21yfoe8Y76lw6sFCPhDkJmN2
2gVIjpoYaoi7fCHNiaDJilS9n0Cy0qPbB2SWa0asNGmnS9SecDz6hohgdrFPx8/SGzy8WF389BRf
0xCEQFiClMjjp7wrvI3lZP3ZKxk8BG3XQOppDX0k0RbJRarroT3nq4xl4sq2PeMl/TjlIcfRbBpM
0rUHFA90dQoY3BXDweD4p5D1Gfdz1XDAigykYJemWo8rouGBgbkM3aDKyNsyp0PW4tNDVH6uNLKh
StdZJRr9TCpSZlyv5WMd+dHXaK27NGSEJCX+4MeQl/THIPj6aBoi9/3EitM8FNEWfD7/VsB7D7ev
Z7ZN3ZVTNoICqBKFf/0Z3kpIkaNmuvec9N4wUpY/ZO9Xz5HnAT4RRUGO/7BfZlAQHZICBGfGIOBX
9jorWRsqiPdE3jdDyYB0d+1ygy4ObC+AUCyxYQVzPiYhbQ/VKWHdl3qBJTv0fFV5ESpiJ5g0zahy
DAGdsCtNaJJZh2brUzUd0NeEzFMJr5Zc9OHG+nl7mFFxlQmIoytNyICUzMFpA1JbrbzRUcO+Mcsg
V6qWFjLRKzOw3EQpLxfmZ2iL+yeGo74tonF9Hfsg2HVLtEDWayqik5lil0k0PhmaHKzVaQ0jrDu1
LuM9/u/6nvXRqGBiXtVFUgeh+lo6FqRhA1qONwTtkdNabkIzov7nFuOeZl3XfQe/u01BJ/4djQJ2
VP3Imm3FhiEbmqg/t9TkmxzovSy36NPkrQjRdwA+eYtUJY5AcKDBTx9eQGkDfdkts2t3D3Yh3bql
rV8BYpVnyDiJHQll8znsUPyDwSq/9WttNnBZiTbzsqxHhWLTJpDnL7Mx9r1XtxQ8zdEfynJpATIr
gwZTUxIsPwPqqS1GnjPHlKt/gcctOc5eGdiE00qe9DS3G0xcY6TR0foSj2jXpUWz6reqH8wrjD5s
lKDC4TcqNF1GGOlwo6NzA7sQfiSTjc/e0oToLgV52nbokU9C9N+61lt6tGggzZVE1FQQtzXrhi7t
AKms0EASUNsMdXWfzUojqZTjMuN4SG/aOT7Z287WiOoSiZddXIdV7Pvj5Ef9E8ym6rfJj+HQMLtJ
Ino7kg2hcSfFFD91UU3TitrqjdjIbm0/Di+Bg+q1hFzgGTW+ugeHr//iycV/cTwK90bU9Ox7BXo+
oT8C/ewtkPcdZVxuxEwg0udIVN1fGh0nby0uOymokahEsypT2wx8t4IT/MQVlU8wGiSZXAZ36PTa
7iWqwJ02LTS6eijyM0vLu3xRebrAUebOdBNuHLWQ7SB0cwsLo9glNhQ9FBmr8Qtbl+bukuRlfpiz
PnGC+D9GruKbcXQk4WuAshF4jQ1lAN4VBomWD8wPqrqGYuFw9ftjNew8qChkDrJAgAXmzTZi6KUl
nSb9hpZ98RQVuGKUwugnxBumKGe6TRxVfrZ6EOJJuy7ngMXn83YO83AT4wbaDssEA7lpjBMzqOWG
NZQXmzpsyafchMi4rBxMMlx8OgGxY5s1t+HBgyx0Gk2TBzXCyeuzcTHFLbZGT1Kt2u7Jq+SILHLh
3iO1y3gnahjdgcU2fZrK2tvVtenOA2mnraKlgjMP6i1IGwb8KNcJlGSwSOyXDmlwCvPOrsI0Camw
A47udsU9/+qP/vwDiH7x1NlWZS0+bWqHCQrsIU5+UuXAx+L4j1ULr1IPep7KC8xDXUJ5HicYlAih
x60P7u3NWtTsAEWzZduBtb8fq8U7XGrD22X10SKabcwRYnpkXLDkgQKCHtY+pWHodoEq5IaMo4ee
WiPuDYOCTsJBz8xM6AffgzBcBuy0UDwvZRVuuj5Enjea7p6bKrxpiAd7LTFEcktH46EtjYwJR2+4
kUXeNxnh/pAVcaUOc8PyBz7X5akQWJstixXeKqYd2a+eCyhcnxDxphk+92E1RxuY+RQ7Bb0/zDz4
vGY1uWQMsVJfmGjYBi484wSnQDWew3z2DxAwA+8SudtrFXrqRi8+qoGc5Y9DM5bP/jJNN2CKk/3s
5gLLyx2UgMWIVnG+gknGrIgPIZfqIKBit43RLUxaBMHzKMwCr496+IbWtUnjMSoSBROTI1CFoUst
4DvomXQ2UPBWila1W5U/fGKD0jsjaHWccpA0Lr5f/RvivL5r3RwcYH81QUIPlpLQXAxuIRbe3qFh
lL/UxKgbqCfLTA41hU9CXmWwmJtx9Rl+X8QorOq84y/hUqAw7/xqStDucLs4YN4vukZks3gM/9xG
c/0Tl1oJfghpoBbxn4ut0/bB8MZ8pgs3SbBgu6/N0t+stZS7Em26rcZ/nOUqYNs1QNua88je5mL4
KlAMPJXRGGWIU1EioMS3jWPp3cRr75+ZhoKGDmT54hWhekZXJzirIeApjlULK1zbV3YL+FqRRXXd
sYwjpt9ANhutwpA4skP/oYk3xHr0ezDEE6KkUMEdn+F8dF9NfJpSUiLd1jHLn3Mt5zur7fCcz20j
Dw0sjMMtqwx/rQyu7ZSJyaHaXHL9farNeF8yPpCUOTS3E4v2+TORC32e0KcmiRjg40pR2npb+Iex
z0KUs0V5TT7nbkZFpMIEWLz6KSQ5cJEKhLZd4LwQzdrSH3eepbALJkhzsjYYlqPnKIx4dGAJvKXa
eEng1jxCH7RVb/Eyj0+2aaxKWl13XysrR+AYwpA9xGG97I2M8luoMdpjjmD40xZ9/YU3yiJN7sZP
tnNjtEFAnt5KjEv3opIzhdqB+2h49c6A9NpEyShgQAfeAZ6wqqfWhzGfwFWGeQwB4A16mzjEr38f
k/2JvXmZYV0NvSdAtwDZ8bxDW4jxpnJrgfTcNvfCK6dHmi/NQ+/V3QHWhPU55K34AL75nyXsn0ao
VwPsdeYDRmeyPVaxX2aTqxkgnLXNnLIXL+ip2Q62b6JNbmdo6oK0U26HlXvweqJ0N3WwHqXg7e8o
r2EtpOaiStYSQpQSpeHz1Pn6dvW78a0PzZDacvB2IOz+mqigSM4K0ADCODrpzhzgKj/mKa4c9BY6
uJw/alGhNyenqvnRRAbNiLoE0VBXpcOmGHu7yWWBPnzNNBqUSPz8G/Sv1g6Ned+UaHGAs+nVrfxV
I+e5lxWEPTydD8ExquSChs2sIbw0oIU0LwQeUS0mSv2Iwg5JSnwGFy24aSb6k/ZsfuTzEuOcwVh4
VsAUDQPtPw8aGbgo8vCVVn77CdwzTJsCFDeemNsdm9C2mBvlbomf2xMdvWVX9IOFw/rayTSIoYVq
OzREg3p+Q/2XJzqmPIlXmn+A23lv315hB6BtwhF1Coz3AqjLgWVXZGWPu9IClrihooMEIQRsP0JB
XUa5f9pDVyPe1RthKlhixMvYSIMU1cP4Y7BjkMJdCDZ/i/6xgKMPBCflwSmHkD6WHU2Ypykiw9Pf
j88fwaqX83MFM6hcnSNW0uY41fjUQegS6P8e+hqyUwVa7X6kPguIyjRwCWRj+Pz3p74zmr9m6Yxx
08qc2+qY52x4IQ6jGmD3gw/W9R2AwTVRZ+E+JiIBKY4NnG5PbjZ8GxOx3AWYIGOABvfgD1AA/+E5
//ABr20nXBjIXKEJdDQd7iEIxVwADSKGG7yNg/kRmMsi83AbwN4AqenCLb+pC/4dn3KAuIz0430P
/8GXqq6m+6KYA/Sion9d4ytcVTFWXgfcVn8EresVHej2Ba6Gyz9+wMvS/wZ1WrXkKy9D1CkOckD+
osNHQtvpA0jYe9vjCkgFLn4fM9PLYwUndErjVEv5wQF/95NdnvnbXz74kejJbHrg7k34Gts5fiQ4
BN/YNC9wEvTCz4xZjUS29PfLBB3GaMacSaBIzMrqwrScG3PfU6/chbaKD5EHbYu/H4p3Yg+7ulEm
5JK0iKb+qDAISIuhfClNJRJe50/cBiSV81zt/v6odxb4mihj+Oxkp1sssMiTUiOF/zdvyfiaHTPD
87cZFnQxx7huE9xhy1cX+90zTDqCD07de3/81caOMQJbQzuHB9xA950HqHvt/kFoAsHwmhtDq0aE
kPzsj9ZAp3h9XMjL3xf8nW97TYqZUHsWshm74+jm5TsNi+CgdRM8VA7ebwDFTNOxBh7l7e9Pewed
9J+jxW973Oc2ymkJ5JND0eHNtwH+x4kPANnvwRz/8+D57dcNrnDkzIM6Lp0HL2/4lV90vuZ4u3Yk
3GH2UrIDWn1yTYGBllB8L9f8VGIaQw8Mk6EpqVi1fLAX3kEwXTMGMAdox0408kjQ2U8jNKiNNZ8b
+AFCyeMAnamtRdD/4GHvfUT6v6EjCkuY8YVVd5RE7yfPf8xjxdKocT94DGQs5uMfBKl3LrBr9s64
Kuq3cJA+rvl6BMd0RyAU3/rfaPHBPn/vAVeXvqe6ZWqGXB7btgIQogO36UVRG+9KV4qTP0NO7QOk
5Dtb8Zoy4voi0hj7yyPt7iUc3+cxbdroH9YJ6oj/iQ38thMt75Fw8tUebbc+MEy12mKGvHiRAfX+
/z9JlydcLRSFxeTSzcFyzB1aiZg7jLsYftIb3df8AwnYP21hPOJadBotShoyJxdA9tdffo/p6lJo
eyRgurVJP3M0CyjstjHPcOs/fJTLIy9/ym/rZiQagor24ynII28DV9i30h8WsIO7D2LEn/bX5QFX
IVrXax0XId4iLMfg3vE2uoMtd5RVBbtotqJ19/fP86er4PKcqzQkL2F+AVA3itwi2qOjtiGC/ONn
uWzo39aoa5qp8K2Cyyh9iPmTpzTAf49sREoc30szf/Ap3nuDy7//7TGzzyI96K48eY6cRsWfIe/4
QYn63k9f5RMurJay5NQClmjOEJI9FmX/8Pd1/1PRHRMqrr6vMQ0IbnHEjiO3FGPPUs0bD2PLTUgA
thBqZBvPwLsATZbulz97/fbfnnv1vTFh8+NeKHqUbv20mE4lHVUbAZhd0rTLybPmjVQC6ELw3j74
QH8K+pdXvdoHlS7xzdeRnHg3u6xfFghEQrYxqeiCh4oJdMULmO7v7/fnT0avNbqZLSABjZU9mqa4
W2S76aT4ILt8h5MG343/3WmT7QBOpHiRsoHO5KaZNtMnuSmyIGvnRP4ARkvd9vf2ttnIO3f/9/f5
cxxAd+J/n+ls3jogFocTWdmhXCP/JkB2jQbAojJJ0dX4+2PeW7arOhp98gDAVd6fQHcjB/S6uk+A
RX7UE3jvJa7ugLLLMZnF3XBsqvCtWqGogNbDYVbVup39Dz1LL/vpupTEPrvW5dbWc83U4vP40a6X
d7q4197zPy1PfHVqGEQ4RxdryKeJ+qVh5VNYeNnff/q9v/rqdERyaSAbGvnHNZQwaXFiH1DTgLzb
fJCpvHP8rrWq51blwEjANNLjGGyvX+dSJXH+BZqrCQs/osS/s3+u9aprEuW550sskKsfAEyFxvKi
/+1IX0tVs8VFU2UhdkOHNRnanwTOb/+29le7vqYWYNW5IydTtvYMRb8+BeU7OghJ/Q/u13fi/LX8
dOUbMcKUWBwH07BMzRMtEugTAMnY6WYDS+GqS3X1VQ7V1mnWvPz9xd755tey1FMnh6ImMGqbaQiw
wVo/V4LQxKj+tp7b575jfPNvT7pKhIpQTNXsc1hjxp+A4QbOOtPYZ1x/LUf7b0fkvwbybze843Fe
ugjC4U01zRgZXnTxJODGQyA/qoj5fwnPH6LHtRo1upV1BLQmRCk8WW8FIPZH4/f6ZyQ4MFcOquS3
wF8Gc9JCbqTehSWp96O/duBmFKEFt7LFxChhUAXD3TDqIwSUbQpQWIDfioZND3ugN9LQJilBYsjg
qOWClOkY/rZVz/MDFKPCY4kvlfaCmGx2OfsZtEQcGh/5OcYWZXzLOPpuPnAOGTEY1lET0nNZLBgM
NSjTQDPC7K210YsYq/jZ99d5TMKl5E9gnVZbK4QK0fbV6423tPJMI8OATQk7EN2qPt8B2SuP0hT9
N4gXzNumQRAag7pNgSHD8K2Mmy0FvxvEFLSZLbRb4Ubq6Y2M8eMJLdZoD4xt9Algd3ljook8YPi5
3BhGp+Pg12vWiKZN50s7ihg4+zXa5HtgF7t9XPsYyxSxh9EPd7+Qm4Q7DtG9ZBASqEzP8Of54ozq
kZDskEjMYLTSOQMQAv5sbYQXD5bu7KHZtbEwu3maaj9MBsz8H6kHTV/MVl0EgCunW6tJewBbDvlO
CXHuPsQ8tfeDeovz2W1rjsGrbfTwAlwR21V2qT4NIST4Bw12cVALoKCcgYVJiNbaNzhuLxnEXdST
5ut4XIseVnqGn0Y+A/sHvNrB9ovc9LMDhMuQIVMazhpNSYdbuJ/4DzwYo29MGii4GFCA+rlfDmHX
YtJH5HSKqtXeCOvL7aoih5/C+CeKg+8DGQ1EdQDWB3Y74TDYRS1QRynIKS4JRHHvtR49WIh9b2FP
80OagR8gvUGe/GB8rpvaYLhX0e/QtcP4XvR6fqNgJKULIBpNAnZyq5NacpYCx9H+wjRapd1q10Ot
hzGLVVNm0O2N7ivIYz+1JrZA37diEyvr3gA37z9p3Y+3cCqVmGOsv4A5GKDPbas7DClzLIAtbsZo
/BRqVaLrSWd8kL49WduDIemHegthT5Uw23+Gm11xKzRW2K9Ve8jxiwdMQIFgbVrepmoe60zFoX3J
q2U5rqwkO5CxGfg4aJmQPiy34Sp40itwsJqwH3aKOvaNwmrtPJRoIxOztt89AHEOYrUzUsRi2DFk
+5vSJzk8RKB7rHF+wrQH6/M8cIAVY8bwkq3OU+xolQkNJRBQ//6bkBfbaoqmewDd0ZIOpMhAGFm2
ftAWe16Aa9IhpAD0Cqxf7GhqBTiB9WK7jA0huC45YBmvIcatD43GMHjipshUPcmM2xDDWOuTaaO5
WAB8NW7DGxQEgNQADjh6Xgm/cgJBegnM6MMQM3IPCzwAa+JeHe1g1l3LxgBCXtXPnHXAqPIqzySD
SlzOwnIf+oLGCYZ+Oe7VCCaIXLv5VnRd1QIc5IvXlpQ8KWgEeRO/zQFl62cR762quy8+xPvLpML3
ubeuBbZvnCiYsB1U8u8wRI9vm0DIL6HvfbZtO0SIHQNqjQIhZAOwjti2eh3PTmPMDytFtNjaVd+A
yj8BxwvlobBDC6IDjRbMIdq7e1dgFxZN6DKiZXwCv2XaCFEMmVDcJcx00a0PtNOthRLAtka1dFMA
xXUyfqQ/Y1dXn3NG2CfsneURuiEL4qk3jhwQknUAQLVxPFmdWHf1QL1HKFipVwhsE/gCwG6vzSd1
hoEf8zI4C+WpMmyJDj6sJ4dUxSyC7okKEUgB9tn7iyegvzLhbLa0oM9DU4L1VABH6zXOfhmXAf66
kM/feKXIZaLrUhSbEvBKHAWgylPTlnTfKAEaCFyaUmOGZS8YY3du0CYDuqS9LSH2t8fo1KWlL6De
ENOg3dsVSruEVeRu6Rp23xZAEQzOTVucYGzTHmdBwX1rW5HF7JYLShK0mtEH/6gS5sBIoT4BxDZm
jNTuplGlyfyy8reV6OJbShbxaFuQ1guHkauAgXcC1Xr/Du1YyFEPVH4fgbLb9pMubiUiTqoCx7Iq
5H1a9xF0YQTJjwsjrkpKkq/b8qJhWQuBHAjpVwPAaMOXe2GNeezqoXkiBuKZPbwYN2BH1DfolbbP
XW3zpHVSPddVDVvJBbvnoHsCkvtCyVYxYOcBNszKgLgDWwPyBZIq4T4HmQcoXiVgH1l0CfjeE4a/
dr2JC2D8k7BcQCh3Admhq6IfOkivHW3j+heOUeqmYXW0g9hwvJvX2OIfLzRVfw0O/VqOzz2rcXWp
Pn+cAfP7VkCddgftzeiBmWHdNVZXOCdEpIRw0FQ8HR4AqwGga+rH8wS1jFOA4P3GfG95boz6AYNI
H9ggTC/HedFNaqGycjON1t4Gwhu/zoECNnKQYPbDXH4L+9L1PK+uLrDElsGSfNG4zGswTRHAsYs2
dQvWZjLNAdza/dB7hVxV9TSBWPF1hUN45hAW7qg01ZsZgbfMadGllDiKlSTjJ6DToHXvhZAYj3yF
iyWvhrOhC/s6OQdwJzzCoXvVF96hWS/JmJmG6ckQDhHmllcZg3DLzoJRkihJ3W2uevWTTJjD1DyO
YMNxAabbGYRPUpSvcqzKc8Gr6RFx250RehkGjI4/ts3anTVC3L7xPPGLrZDgy3pt6DGakXR1VRxk
/giucNURgGnmunqdO49vSdc3h7715/00WXryfVVklrnAhxYSA+kFohXHqkDLO8njRYK+N8gW4byP
D3xtwNEAEe97SacLxLzq7mFfFXzQ8Xmn0IuuugdjYIJ1FCMEpEo4CywV60GYgjElw0z+g37VO3V2
dNUsGNykQz5E4ohzeIRXEiyVcS8Nfb+JPe590DK+ZPZ/SpSviiYeg2CkZyj8kWkADNTQs2q9s6ym
LW+LA7BwHI0J9kGF9t4bXXUOIMESI4iiQusNKIdAoUSyHpOy1ofcaz/QxX6ndr22CpBDL6JyUuRo
vFXBSwbGHeojm6X3fvuqPOpY2UXlWpGj7vWLHiKEEBV/ZBL13o9fqr/f6qK4x8A4nrQ4FiF4LCsw
7Ef417S7v1d27/z6ta1H4LdNAJbQdAoG70u90u8zjT9oSbx3FC6P/O0PDxfIR6smhKw+MLIQ2GgP
StW3BDjWf/rTry0NPIjjRuEClqLm1KSrtQuYucs/jAbRZrq2M9Dz2tdNi/QPqXC3DSq/2690BWN1
iOYPpvfvlO/h1fq0A0Bo6NbgiHkgevMJutJLcEYO8dbH3aNT7uff1+md0xVehaSo9enagctyRDEF
L16Y9nKRzBNkK4Az/rdHXIUkpkgUhM3sg5miU+t/H1t7HMRGwR7g7w94Z5teCxGFkuCPHhkobgop
0jidxzr6t216LUHULnPp+lb7J9m8eLiNxuFhdB8NeN75xtfyQ7qEf2TbShCwOVQCcodrqvKGGkjP
egdpG0AbDTo2f1+j9551FYXWtgFmxqAJJZe8O2ke7ybQVMIBdKMpIAx+NfFH+uDv3A7XWkSCjOjW
iBVqqTYQWdiWIK3RECwggyx/AWYCqP4FYr8QKMr+/nLvbOJrSSJkT10gQl7hqodyWmjZnDirX/6P
s7PrrlPH0vVf6bHvqUYggXRGV1/A+mItf9tJnNwwnDgBBAjEN/z6865UnW6HbRZn+KJ27dg7CCTN
KWlqzucdwStFLUG6EodfiOPNyURpaCbQD4vC4xQ9tAUEpWpzk0/PeZR7yP7bVu1X0q2EDJdGa2b9
SOHrNYrvAWAuf9nD56a5QxFxj7FKjOfLXbbgf+f6BqB4VG5fG/lpMnWgqP4OpMamaJ1sZb4t2CSb
Gf3ohpE0R0aOE0PZiamtL23fTCv7j6Xume8/VKETYSFQh4Rd27PcYu/aEIsjybahwycIpK444aVO
mm09lDFBVD2byFG300+kKz0mzXAo02LtOxY6aU4QsgZkITs9CIdOZRdBjpjtTdMhEHF5iBesYo4I
qlJFUO+NK8szMAS1UBsinyGwvi2MNX7aQv/M4UClEgYTCnKco+B7kfPXUOaxB5n3lf3yUv+cv+zN
JkHYWjLGoYqDYycEAPU+bsvgcucsTKF5bnVNUou0E8H+IIJknwb/5Bcq5jZTjHudlV3Cgh+cJ1Xj
MIUwgjVB7DKDyl4iSHOHVPn0pLrxFuWaO9uOpq0RRu7m8ictjfdsKa8HZOK3OKgeFUMpSP+rZXpj
Ji/NB1XQUfL753CUjjJ6WuBidQTSqEOIoix/suLlY28/s2nbMijKES2OM4U+AJf0CeGWzDc6fYuI
Cv3YTmGep5tWFFqAHSXHs1ieMUyfMshMrni8BWOYp+MiCtXwmkX8WGoTdaXmQ2+Ax+SuZFIszNd5
Oq5gvIYczVlUR1IgfaoUxXgNx1nVDIqKokRUQnTkQyPxN5URSYEQqsPpJPRBAK1C8+9J1nkI/61M
1KWempl1lCL1K4GAyknj4kK436zhRrrFyhAvWMEcn69SmiA0hQwWkOY/FwqaUwTB6BwwbU/E5Zrn
XvqEs8d645mAcUCVSTSMJ1kCrWtZyX0xMgshxGHlMxZc3zyPNUfCWp2Lkhz7sECOZv1qSL6SxLDU
QzMzRmiuVRCFgV9i9Araqs9jgiJUwHZwrfbr8hRamq0zYy4SsPGKwapOVE1+7eBmE6yBxzx1H+sI
8MZByTXo7FI/zZZoxJklEW7enNqxxM1BxZ4tS62cId9Nc8Y5b57hW0krg+RugYcDvYSSXCBLzII2
2zEWB7fogqo392D1fo6n8ZtF1K0b2197kd41E713EnXfSPIoiPl4uVN/n13fCbvM04LNyoRuKe6t
jmnHITfmhucCXtnvmWP0N1zp6HbMymgf0qI8GRSgtcyyrcCM7PbFjRrxYHcD5DUmO3+kSOr0lJHV
n6B1gVv6VrX4M0QwH6lGZkvTjsBrm315S63OurJJ+WpTswf3vLBaTzCR30L12LnqFaqAkZeImFmk
svsJ1DAgG0qMcjVZ+wzY2R16sPeMtg2vQ5xmAGwxyXUGVFggccqB1GtJdmRq7cQ3BRLGDRsXPhNv
8iPCftnXDLVOG2VN5BAPRG7huFGcLbEalBnhJ2nkIZSHkEU2hfgFYMzcFzU84yTK6CYdRPwl7Il7
QO1ssesj1M0rCrcs+6a7aYXrrHizhRlonW3gjSsoy0GUNtLhT46V39p2GVAarmxSFrzMPJM6ygRK
WxykswiUtdEr6d7TYeUw85tl/t5kOrf55rV7jRLfjDJ9ao90X15BKErXHrtyD7kfbdXBuk2D8JYm
XnWDo9p1ftuueJ+lbzp345t2BU5qyHSw1Knk4Mtt8z5HSV9bEbq1Uo6S1su2sjQos71QnJ/pnEC7
nMxp/E6L8TlDyfLKsxf2ddbMf+JiyhEpc61jNRn1FahsKNHt6bhtCtFvEbxGWWPt8k2Ujc3T5a9Z
yBYXc9JzyHMAcJhZH62q34GpuFc1P7AQOTY59dtaPQGUvBF2gYJKcN7KctNZycocfM+Vu0LMgyuF
4aIms6oaqHvdJ1Z/A+wzeEESJVzOzYQi3MtfuNTKzI13OmpbRPKrY2LgalXmdYucCuuoQ/UtTXEr
i0D+x1qaB11wsQE95KjqjtAx/2aN1pMts3gPQhXSOurxF+2GeHf5m96b6ei5Oe7ZxbW9HmpTHyuZ
Ch/JOKh8tpHq1sGlfqyFmesh2EblJkSKjki07W8B3OjvIgd3epHVrcWo3jOk80ecNxFvzHW0hiZu
RqGPwq2+sxxJBS0ugS+//nsbkfOzZy4oagYD2SB4/RGET2E8WZO5NfQvCVba5QYWRmB+vm5wJeb2
VtYcEXXCRhDYtHQLqAmueovKWgmkLMzc+SmbmAbgKBZKWPMeaghJeZb7QtJMYKHa6ZSVDDiUNutW
tgBLHzQb8K5EthEcWwbYe3jmtuEitmmoE+gUXMyP9dlswFGDAigisIOBIFesdraudQhxU/exh89G
vMiQZMy7Qh+pVeb7HHeugU1Rct2WjVqJGbznnTGp5qfuXkgkYWVuetQEdcxQniL6RabcfQCUFiyp
nOC6eahdhhAhKcVKowtWYs86rQJTNhI6zI6GptdjaTyeL7Uvd9nSo2ddJlAf2MiuAlpGZfy2Ndmv
NkrHlcm79PDzz99YNwJccWhz2R2JhAB3WIffUGGwViW4YBnzI0zduSWLJDeO/WBmL1k0QqFS9zS9
BnBBX3VTQR3fqIW7EjNdso3Zkk8zJw1d+Ffsyvvv2cifwJP+VurqA/uW87yarfq4CLCEAeIOTk1I
9W6TQQWmWxHkzsg14bSF0aCzU5PBarcFQ5wFyiTNNgqdfl/3tVyJIJzn4nzDd/6A2RI7FLqNW1u6
QXbORwLvrBi8HGg8Z3q4PFMXGpgHQJDY7Q5VbpdHCgjwt7ZOQD1uJzHsynxAZb4V8mR/uaWFjpoH
Q0baks7uCMwtJc2+hoLVFbSMs83Hnj5zsj2uLSyaseJYtXW7tYEC9sHjKlaGYcE/zaHnelJgSbdl
B1GvUXqAMNM9sB0pivBz5DIpUQKkzH80tvr8sa+ZTaoqDyEQ61r6OE3qoThDQvM15fUlA5/NKDLm
2ihMVx+dUce+EyK7K+/YNW3yQ6sS6ueyWrmGW5ha84N4PtCo17ysjilO27JTe5HQ7Zgah6Krv1zu
pwX38bfDNTA5LSkAZJej8RiO9Sfujt/q0ShX/PjS82ezqoMmi4k04goZeNSrErXNJQAS1XS4/PoL
JjE/Khpj59JK4PVHu78pyqIDFC+PVyxiqftna5Cs01y6oqqOTRLaSHNOQeDA8b8DOMegaxkBS19w
/vmbtahFlp1sKMZ4iN0BbOm432eg9n9sqzyvt1VVV9QTpfoYg2UD5Fb8oxiI64+rggxL4ztbH5w+
xIEacl7HviKg5FXpD4SlgHWs1/pnqYGZIY9jJYHBDTFB+y/a+dKMt1m40jm/K33fWRvmgmcpgGyZ
wYru6EDDBElVEvgVjcGG1zaN4StIhNW3wtbt53LoQWPhrTzJiY4HtyfDjsjI3uoIDMCmQWkDjSC+
STPze+sg9IPaFnslZPGuDCdWsHlB5ECxXYFMbBjkYLRwL2ub+r4SkrkgLeOKyy5lfEiBBEq8sRPs
mjWT2iLx3Dk5IL6BzCGgDAZWqhFm5vay1S0483lhbqgmFUEiHBJlRXgadHulY35XkArMnNZvNLtH
QeKalMmCt51XaUve4ebRRtihdzaGBRY6MrVBot6aSFXFXczlD1qw9N91b2+MsKPxxCs6hgHG+bVu
EKadpulGhepVsLVxXJjIv6Otb9oYyCDzqRx5wPOTA+pbbRl+DDLu5S9Yevr552+ejkitaZaaGedK
uX6HCGhxayGz4lsIWvgHm5h5Kt2qWpHBMQKGuV1r8MZwxbDXZi0+OAqzraxNCjOaXCsMKpSfbIwm
v+4VHC9IVYceiZ8rrZxf9x2j/x1setNTouFqiEuFwhPxxW1/WdXKDmdpBGaOylCSSG5LI2jI1eAA
+tU9xthDXR7ed2PycALzYnJHMcMc2ykMzLDSJ6O37asStXNeWMUR3E1M9Ma2svIVKs3gD0aD8MmY
pidD62nfT7gkQ8UQ0MbAgCKMj7RsoIqnjx0R5kXoSWhIlNfjw8GQ9Psk3NTTHVP59vKXL3Tr3+rN
QcgqkvPTa1RwxYDQysAyf1x+9u9i/3fmwrwGHHwkO7TAhQuKTuZeDdQu9GZKT8LRA/+3ixGF9mqO
sy3IUV4/anPrTulKlsWCYzNnFkuNjgm3JiEIXu0twFoedNi8NMl3I6j05RrkYqmVmdHWZQqqutbx
Ma9sz8hMcYf0fHcHVNXtFHalJ0Zz5dpoaaBm1iuxckklzuAdCE8dQp3rHQBuP6WNKuvLw7VgueZ8
rxHHZ1bfEB+p+FL28gRw78o2cundZ7ZbkUhMJONhYBfWC7Bp2S7CDtsJ63rF6Sw1MDszFBCpNYrB
DIMeIXM/MRJ2CzJj+xBCPuhDvcPn6rRux5NJFPAQZXVoIX5qQljjI/3O55q0bQ/wrACWMMhSxNsr
MYD1lqMA6/LTxbv+mM95AKENfETb471HEyJYZRM+mzZ7afv4O8T77qKRE280ULGi+f5yg+8v9lyc
f/5mARhaqorQMMBfkkMddIQ8OzJ7rEUF8ZZ4Tcn6/QHn89L/SbGGRa4donan31D1kFLw+/t+ZTl4
fwPG57X+EmwGBhGpMGgqeRPb1Y80a255V4MkWfgksT9nEBW73FvvGx2fl/47Bgi12YgPsaCbM7Bw
44T5ysKx9OiZPY+Tk9glCGOBWUBwS8VPafSR3FjAmMTMoBOR1HmR6ORoA9nb2Jz6E7R3VrpkacbO
jNkQRlnEpEqOViogb5i6kvkIWDrutighcg2BN2jwmENfPQ+TK4JaqPFjezA+r/RP+mGwjGqMj9Bh
8JiT3ND+NI706fJYL1jGXGU2y0cX8HZ8WDM1PsSHmJn5rpP7iq9dUC6YxVxjNgnrbsTYJEeaNpCl
Gg56RBHfALmZy1+w9PyZbctS5wJX3kZQJdBxmarNEIl7kYiVW8GlDjo3+8Z1wMNaRXW2asB7vTIm
XmV+49m9sXbjufT8s6W8eb5rCoKjJuw6BR3Zq2JQKiXcecbLpyTmZHu5kxbsbo4sqAqoCPWQqA9Q
tXcwJdu1Jf18+dFLHzAz6QhqOyJCtvCRlHoDcUaQfm9wMPSq4iNp9bBsPrNsR9RcJxW2GajTZemt
QdidEd60jKwct9/fMPE5tsAuiEEnaNbglKNOREU/w0TAmnV7IEp/QTHOWmr6gg+fkwqyAtq1dhrC
sba5l2F/ObnXwoYSXwbL7h+UTFbc1YJN/FZwfDOpoKUD0ghEdwI63CL/2VfgEIGE8zGLmyMKkPkn
nBHY/MAl3WcJzSOvT8kTq9fGe2GyzukEvVtoEY5VGKjURsW8tSmM+vHyZF3qmJk16w5QZ5PAmomE
OJadetC/8Vy9dtBcevzMmOMsDwtLcyMYGX1hLUIjGoxo1BPD813+gAVrmxfWIafJcQwTCyiWZJR3
o+D089Bk/iTdlQaWOn9mzogiUICGcCLnpX7KoUc/AIX+sXef2XEKSB2WReyIx67a2PJJpNQfUunZ
2cPlBpa6f7ZKI8HLBYAJeD8bdNRdBacU0L4Cyb03wpVjw0L/z+vnOoIS//R85OEcKsdY+J29ch7t
8IO7GOfsOt5YbkqA1Eupy4Peaq6ECQmhsF+JViy4Oef88zePHlD07owKbs7JHfrMYqP2xzH+BSUJ
G8l+pH7MtYpXumlhFs2L0qQE56IbO9wh9kW/zY083dKBsZU5ujQIMysepAOd1aYFdtlENp5n17m5
M0totJVIkrzOGpGvdNlSQzN7ThxBOdJ0oqPg16S558ldHb4w8/nydP2dnfH3WASfl6RNsoICIIeu
/PPzbWBsb6+TB7qn+1PvAWvgge7gW37hnUL/FXwHz/CoX+9x/eTbG2ygvM6rN/WGHNlx+lwE7l5f
jah+8Er/0dhAwst7XXlLTI+/v6Q931e7OjKhyDA1J5X2t5wWVzVRK937/iwBcXE+I5UYTBY3Jy2c
Q1KzndOsoYgWHj3fNcdFIqE6qhvkKj6FxUMqflzujfddjD3fL9Moi/pEIwu3lxBOG1H3bUfkzolX
7ifOZv5OZ883yxYrCgSCdHEsaBw/NLnhYq/vdpt+SrlvAWThmx3kXkCALFZiUr+v/d5r8jz337iF
GAy+KqpUdKqzGpfXeTlOT1kOPuuEwMtmgvRV63UgzJ8IVNhwBRLGN1iAzpXwddJuY5olJxdK8ntb
U1v5U933XyHiHEH0CIXoB4tDRclnRZQQr+GlE4GT25sBBCIhTuJAZfWaQTABK3xh+Jntdqhpombx
4Azx9PljI2b/+X0CWbSKMcxZN6r5PUgBZMuhVbozGS9WEjJ+k3Lf6cN5ahQKOVJoY6fxqQA0u/TZ
OXHCCY0vfVGkReBErARDIM6MUw9Ahp+c61U4uMfHxoogpxtDuxe4+pigTBFiO5+JzqnHRdmegQH1
CEGdGlVrZRlNfmql2V3REOOrPUYd5J46BwnRyTCsTO/3HZ7NZ541bVynroglAsjwmlBlLZInF1BB
iP2ajnsa8v6DGxkcx/8cFmggElZ3RIC6q8LXDndy2Ix1vAQZqdUgGUXKIStGteQLZluazuiKqa64
PIq4gUYbViYcdd2Sf/3YBJtta5pOVnGXA59s1vS7y8vrBuoDHiS4+cpyt/T+MzcZuUQrBShV4Ibk
pgqhkt6UT5fffWG85yeSsO/I0AHNiZiYAa1vF/n/041EApPXK/JyuY2F158fRkyewsQtw8XrN4+V
5huV5Csju/T6sy0N0lidUvIYF2wRaqKTRwsyxTaUwEdkPl5++fcDP/bfziJpG+ZuDgiOxcR13UU7
BkFvWd4lqB/VJTITlfVaJM72cmtL3zMzvwKWVynDdIOUDQ8WKb+MVO0zCq24DLSoj7VxHqY3/p4a
TEPf0aWB1OEELFJ1o8cGKSwugCFxXa+MzMI6OT+ndNpEMrVGiLdz0kfeOFeMDA/Y7qzM26XHz0ya
VHjvEDlEAeRoxTPu3uoHKKcK6GhCqPT1ckcttTGz6wFYAqAYHR5EwNKjjh8oT6+GRpdnSQtu6mON
zGy7dzrhyjrjAdHGLZm6L8AZBYnuV2xv4Rvmx5XIBJR4QipLkA/svk4gRKaxUVRrOOKlx89PK+Cz
D6wWdhBxKE7n3TYJ8a9886G+mR9YOqerm77hdlDxPSSqQK8BLKtbqzt7/ziEY/OfdgACREegTgz4
vLEL++lahF8d3oL2ZwBEv7v8BQv2PMdnIM20NsD7tYMwC19LBU3z3iXEc9xM+gAEr2zhzpb7zu5j
TtAANV/FZUztAIy8T4SVkMfh/cPlL1jqpdnuqQaRHXVYlh2QQmy6uvxGmykDkIjdQVQBh41EP36s
oZlFN5DVjW0rQVJrZZXPE0pKQMErWqAUq+hHMSH7MS8yuXINsfRVM9M2xqZP+jLnQWNAQk0eHCqu
zhI20wTW4KfLH7Rw02zPiRoycUYkwhEnsAYoL3pgLDo/psIBU6qpImhnnpHDZtmTHVBGzcZuCXCO
ToFMpMQ1gN68/BYL6xeb+ZeotgZkuTTxqSzbg+zFbsydTU/ikwkApMwFVpdTaK8RgBZam5chDKwL
FTRZ45M1OYEJFWEyhR4q869gttdmWO/qHgcAXq+sAgvNzStcLF4Xna4hojgwhx9Qsg3fVgozgCx4
46GWL/WQUYLKroxZTgCN63Zll7yggoQ01ZnvaFCjiro9O8hkaHiMjFV/imuryzYEaINbkYO356Yh
lx7k2cZNk0zss5WEawkSC/lh9hw8kti8loynNBiBo3yyYqTRnMJ2tClCyVbqHmkOTTcIQNpIvi0F
ZG25TlErZWoCiWMpsy20w9qNbTvj8wg62PbyXFtYDeYVNEWdOHVGYhbYYrwPB8AjGtkOniHXSvkW
HN28jKbvbAWFEIMGPYfSrNcYLd2hbLNYE2j6rZjxjidl54bf7I0Us5IxJo0b8N85Lcm2jPuHEjku
IN55No5uOefIEyvO+ZqbPow9bJu3tjr1zSeJimvTfGIQdaXsVuICBBLqB26GK527sJTMMSbaHBTT
EZL+UzncV4BhauegshH67F8uj95S584c8BhXwDX0zMXRL/oE2dATxLnvLj+anFeL9/p15m8hNm0C
BhvxAIUqCntN6ia+AQokciPqZDNabn4EJhos0Xpg29xFlmVp5GyfAM7rqalqNhTBs9ffL/OfP4b/
E/0s7v7VbP3f/4U//yjKsUqiuJn98b+fCvCf8/86/53/+W/+/Bv/vf9Z3LzkP+v5f/TH38Fz/93u
5qV5+eMPW9UkzXjf/oTcw8+6zZrfz8cbnv/L/99f/sfP3095QvLMP//6UbQKXMWHn8A+q7/+/avg
9Z9/WeeK3P98+/x///L8Af/86yl+SbIXhW7619P+56/8fKmbf/5FTPYPx3Y4gTCG5dr0XGvQ/zz/
Rrj/gC6KYzkciiaMOueglyqqJkaT5j+oYwMyYLrQb2D2mX5TF+35V3gaMU1TOK5pMRcOmP71/17t
j8H538H6D9Xmd0Wimhpvc55+/zt1XO4I6Jrg4uH8fsj9nMcLzLItxTQYzSGVyXjHrK69NhhkQ/y8
HUzAxkvbiPZIwLBbqLWaA/Mo7Vi+p4kNAGjUjNze9FXDq82bLvz3e759rz+XnvNr2dArsTmhUKWk
zt/uwtIy7lQW47XyNgwhpxpPZAOBbWPYWGMeX6Hcq7w24jCpt5W20zsFxKhecQl/+lt0PDMtkMUY
cZllIpJytug3Xgv1+a3btcWwj4zcdvaRHdUQ0HWydPTG0sTnX/7k2ap3bo/ZFodEEsMIW2Qe7QLO
dLSUjt09HULUjXSu/Qy6PLTrMiCFv/VJ3iNhW0AgQkG42hcshVho0w7VWurWzJ38fhHqMtg+t7kD
ubPZ5qZMCWejZbJ9FjXYKkp3sO6oOUavwGFBBD7jNPdtGYETmphA0poQMnrMIJ5jbNsGkkk+VCQj
ZLdI7SYr0+Lc5W9nq+tYtrC5ZRIG8WnXnDm8SFNmFTzt9pSLPtwhmOvQQyUrFa4Mxnz+oSEGOUfI
0DFHOM587IlQtkNL3e5Jhga3EXTNya4pufVl0j37ZaXQD0C1AQjLgCGBIhA2KqxW5t+fSxKGAR7A
MV2InRCBIP48RmJpkYQQVe32xcSBSZCGJbduPozgRevKjq7MPrFW+vfPjfu/mkSFtmWaFEmGYp4S
0LO4strYbPdJnZVfZZ+hACF3IYzu84KyE/6XxRscKKphJdXx798KTwYZ9LPkBlzk3N7HBAnd09gC
od3kZucZpQmHkxpOiZmWhUDWRwmke1cG+e9fi8G1bMZMasETm7N5rgp3ooAKV3vN+/iAtDWSe4DA
9q9KVOWr5RTa12naZf5lQz/vYv+cxMx1UYKPr8T/izlhNXIEIW0jG6jM0gac9LytfqEkZoj3o4yS
du/WpYtYWxtxBbhNA5T95fYtYv5pR5w6CCujw0Fgwvx2xDx2GPc6hMcruj20BwDcDptn0qGM2u4K
8zoGLB93JTt3KsqNnQj7MEiNi9k4lMkmGtlwqiowb4kDYLclB/ueVroOooaIgxZD9pTGwHdXo1Wi
9jD9kUOxFls5OznEk+q3lgOp2jBEISersmZjpHFxG41jWHnxmLOjUYQgA/AGEIJ4NIBb7swSYgh5
nBgvk8gmv9M9jHHSvyx9BuiR6aQG2w1qEo1HV3S1BzZQcsiHNDzV3OCbolH5c1wOMU6L9i89QdUa
ATnpxSksqpGSP6Y4se0czeLbbMCHm1F8F9kMdbJQrkt4JFAp3eXAthgawPJUPDcDpK/rCLIJaamQ
AtI7Sm8g6NN6jt2dUCPZHEDCUxxVTkbk897k0JVPrWz0bCEfu0G6qLpIzG5jtUWPtLak2ppwoyDy
twlk8rAC7IwJdOJH1ZSRhjA5oYk/uR2DXnPEHCaQGa6A+493BellOvpCFXBAUEcj4tQ1fMJZlOu2
A7yFp1kvPODVz0u1hGXJTShVUko/AT99otu2qqm440iDA7S2R8S34XiPBpLyDpI38DrMqpg3hLr8
muKJ5ZVJewu8K96gKvc6c41Qa88UkZruIBoBB1gWEIL/MtY93HImUtSPFXQc7uq8I87+nOrn7Hu3
lMk9ZQ3+3VIQW/iUEcGhWxFDPWOXOAMWeqvlHe4qHLvo3MqDlniTnBsd0d+aK2lv/rUiD6TN1Z4B
okN/NRHBY4lTQPAVKjJ4CApHy6/ReNansaFN0JoAUIEreWKZCSeWRTX8jAyBk4GQBrQWvoDBjvet
LYV/VqaMMEkAV699A3MISE3w8M+SHr2JF9NC6QHSFrjfy28mhYJ3n3cjlV7qJJL7oTO46jgQ3dGv
tpOzFHBsux43Ce4YDwXHsnFFx0rrTVkZjN/QosWjeyM1ix0UaavqVEf5UOMWvsNcNvOKj1dZVZdf
NUqQSGBSiEb7NuwNHYXtQrFJY3WllAnuvYI8tO8OI6QWoD1QjQEjMnsg+WBnGwHWnnuVG4DX73qo
xVu3JILe0WMkwiy5T2hLm91Ypbn6kRjk55TgItZvQFh/JV0yiOshZeVt6TCr9REQwIxzgPEWG15E
g+ONbDR/QGLXRElfGW00reNfTY2+8pxyTCBDUNCS+WZbAcqdScjwQrZj5KWP8uHO9UzUDjznVkEa
D7qOJ7B8rc53hszY6nGqQDHV7OyPcKVav7QR6FwngtzB8ZCZ5vDkOjHkuAcHx/FdZYJpb+iGE/BL
CunepRm0KJmTR9HtUHQJssMEmZKDi7KEZFOzsEx8mbe9D53uEuxpBMVqAPmnoSoA1nf6AZW1ApMF
AvRx7zssURX0bxgvD2He0TsbieHlLrVbXW6QRTp+m4poUoc21Ua0SdMeS1hpt1i2JEJ9QNr3Ji7j
WDyexUkaSCEDAJqIvcpzbGVaAGHCU+RONjJgqzCMNrBNa1u5eab3BXdrtiFQTMGxDVqlAI2k16qB
8ElnJpALhMaLsyMGD3Ehbxo7wQp1C5Kpc+yGDPriDSP5L4VraF8Lkd5aNe2vJlBWOW4Dp/i146ZD
PhVlKOQGnRb6KkqMDjfiBN2TNE19KJwyQmFFFtsboNZF6Lc8FlDGTjIMfZYUlWe4oYDURQ0em44p
+z726mxLOh92YsrHLWlDejv0IjoBPUe9nCWBW0LHxJS22A/lhKsYKK0Yh5IObeiD1O9ucxrbn1rb
cqAEZE33WEfrA6e93Kuu0btuBC0hMMGkDfKSo5gF2gAHAcDgMcNRyAedqdh1Wd8HdarH70k82juq
RHKSXEXXBZm+mCTVOS5Fq9ZPbOVGUEKZxv2Ul/1jlyOuGI44N/kxZMeaPe+a1kO06YzOkdj51dgY
QZin1ijUbIxOBfB9qdqmvVMO8FMm/dniwAKtSMd9SW3ri1k7kH8tJx3EbOIbCNaLAMV+fDsZZao3
dUUb4yUzQrgohOZPdU6KeMtHEdEddBVFeJPgaulRGZrdpdEEl07Tcsu7kFbbJnGd9oRkCaygGS6x
R4GMThROS/Fc5UUdHydIMyofN3oQiVIikldA59rN9cBr8WOsWfuzxLZry8Moqb28cTlCBDXZhVql
AWukwzHiEF20kbke5MhmQpaM0fUQT+Is9sLCKO/7VgIZFGpyNaJ0PxSmBc/JTXmTDF1zK2SWeGYx
YdXqEN1GH8pNlDvRtq0zLNQyUY/Cpvl2MlvniGtH8zvYXqIAag9f72HLYGyEm5E7WzXFz760xu3Y
6RjgL7ui2TZNVG75megl4jdp/gglo2zXJ2V8nUS6CSwqU99Cbjn2EU0mvQzCCSI1ubmFm+I/nRTB
/VrXBC67hlRRNWT1bVq1fYZ5gYvb0tGRZ3XFCFH4Ni4/oWjUOICDBtuQTnpXWWJKtmFN489mbzoH
poZqy7SM9ri7eW6AydvEcf3aT7jPnGCdt2Yjh9uOW/cMCQB+Eap+D1EMtoUDtjZmHkKZBIdxtXVk
qm6SkRiBS1W2cfrc/IHNYH0FrRtr05rweH4IMWOvGjv7lvDqGLsQNSZWjCHB7SAyQlros0UuZxCV
xXD7uuzSz3RktfKUiIsbMI3TW6SQKcsrKiQ8YGdR9zsFLF26HWmmLY9j5y/ikASDsg2ojSHzoimR
mNIpCI00tQE1EpBauy69pahb/kIJI0DvDE+onPsEltBTA1UoFPMXKCyVE66N6zisb6bRwn3yoO0j
M8PPOL7/kp1AhW306vZRAc0r67pt3fRQwTFuEz5eD138wqKpwLkHVWWURp+SHhUsSAaBvfIJMkDt
LZdhjhAscvp4Vd5IRa1rxK4TSHcPBxSGZdeW0z5B+yLeRYgo+UXTQc6DK48MUMGw+jb71abN6GFn
ttVTEyOrLq6heSBjz60staWGuxtjpwkAfzTxcwUBLFlNN0nt9FA30aYfQ43iM835r6blSVBl2VeD
MQNi9O1GOTk2Wy4EYrou/pKZ6kVoanmJMG1/ivt644i8/zwU2Xe44Gt49bvc1uZG8jb1WtEafiLG
EVNQsd1kZz/jsfsCkqbcMdWPG6zy15OM9RbZK64XO93o5dhb7GLohSlk7CM8E+2rqio9+KH/S92X
LEmqY20+EWWMEmwZfAiPec7cYJGRmRICgUBCSDz9/3nV39bWd9FtbdabXlbWvXkj3EE65xu70965
b9T4TRUBzFCuOP/qwhvR5FS0Jb6TqkXcdZ2g6ao2nBdHgiEIaduaoRFHrqcpjHxNi/ZFrugAQ/nM
aZuiexvAngz/TFelgZKndtWok5lF/6foghn1FwrtDjSZcDyn+2evw6yEt4beOeAWpyxLn5xv1QWH
Z1KiwUWXu7ThK87EN+HTtuGCFYe890MdFjZHLB8r3Fs2GyR068FUbUDaqkjB+UmIgmofybByhn7N
6ACrd/gcXa/CctpiB9E8/Y77GGbK4CXzGfhsONDx5c9RVYj2ndswKvFKLKWbMvJIN3dC6PwhVHQ7
ITJpKbtRJ+hxWdQh944hE0gF54QkNx5DySkiqj8HWYSeIUPetA9PluHSj+EVPHm+m7gs2rCopxXc
QA++77y36p5ucCRM2mOi3UPokoIudlh0lAcyO3J/Snb6wKR+sTAM3ce73ZEKCznBimH0VuxWNGgI
UoeFZO8RKjB/W9SInYMlTJ4pboFn6ImCm17w6AA0pT8EuWOvHGqXlxHlyQ2DqfnTKrF8d+E00RKt
aGmZMbt/gJFEPxqUGaVMx1/e9cuMqyNjX3Ik7xI3y4ML97SMYgnFnMztRQ6O3QlN8grNL/FhnVhf
s3Wa5WFrZ1POC/v0GZVXECGt1LIBxvAoFiIE7dN84+GpRy9tw+LlM4bP/36UkXrWJhzqjM/HdJx1
LScpPqgNUX+FMAcIaFBWdA8IaHwYo/Vg5iC57+eRVfFqwJCHPARttYkNaZtrPlViwdyP4jt4AmT0
hOacOkVb7EORi6U2Yf93wRJLxqXZeI8RIKF0eMDaDGEWjUPEGXZzBAyAJaTBeq4x+CeMVwaRv20J
odiogft0EQofUVz1yjt9l27wamo1+RuDAJPKgHxFwGSxXAxn5N6FRXqBglK/sE3jOlK71awMiJc3
vJ/YrxSZtrVZi1xWwM4QtRmMo0as/0LPggEGraZs9xFqoiZSGb3jgN4sI9eJUpXD3iF3Ke3FPOIh
LtLjYLGDWefkz2GWO/q+cZ+0KKmJUKO2BPgQgNsGGhUvwCXnwziH8V04mBaJOAvyPGWXdE9ovaYY
e9Mubnq+Tq82lGI8tj6BCbrlOcY4JG1gBc71lh1j5eAfUQmracL7E6bHhVd8mra0hNxzRGuRU499
6NKx8jwrsD/gqW6wSKUOlE8w12uK2eXgLXlHDhpmTKGYvgkXMn96VBCBT7ZsPhSY1ZLjAKACmTqJ
oogvk1OMgkOdb8d2d7GCj1tt+K/l/rBks0XLbtHTW89D9pVHdvkqVrfeOJkXzczh41Xx7EucX/ul
tSS/hbCgP2Osw0fQ97LpMKb/NV6kdesLXY791J2xCGJnQ3/RVpMh268GqSUSFV4xIfCbhNtBofDp
T5b2sLW5Tv7I2fJbobTuC78WqBqSO1vlTMJXvpDT9VHFQ57r8BTwOKvwIIYPJoIXRwaG3nYA7T/z
Qcy42XH1PGB44Wes5und1mcxftIgOFLg6E9Lht+z7B3Q0bIf93w9SI9ag5KsGhfmIgN94kFkEjSA
tcN7x4Q7TLETP67FwA3uZXeY2Z5mJQCf+FHE+X6H2FCck8qyt0gmaOFb/ZB9TkJHtxIKgtoiuPg5
cPn2u/er+sIW+ZAC13qa9WhPIzFxbe1wdUpHyuIRTF/7aRIvUZzuN/maZG99R/1r6PKx2dZ+KDeD
5lqAra5SmLEbHcbyBQFTaHvnWLjXUe6lCPUWo+ooyzYUjQymbzJYHlGFOi37UV0DK/u5yG4sD/Oa
LyFZ6mDH3ElajgUFO3+G5Jl9VHGNMwv1eFtBcbPKrNyX7Huz+XMXqxxQDbjcASU+2FuKRzUgbHhP
JiCfaYFY24V0wD8txATwZ724DY1i2NjnX6pdsOSiI49cosJuT1lA8huJM6TcmPjqzIKCOWh/0eWJ
H0UvrUf95ZxhYS8UX5sR/k00o2FKoKPlJSNmTEtEmYevc5YZVETMtipWGphjkej2N6pB9UOraHpD
afjLLBGldQxl7yGRMmkKtCYceqa7kxVEugs8RfwQJUuMD8LbJsrzd6XVyayo2hqi8RgV2XAaTRyD
iDXFRxb1DRPb44YD99655Bim660NaDW54XHB8LOxNT0ZY376aUfxlBvjC5BbFLMEKSz+LsO3JdSg
YdHNkYYfpqOvcpGtbzDdncQctr90Dv0G0Kbo1fK0EbJzVYSGLXQT5iEbjnPnOrRiak/1/cLCfCvT
EKAXPGN2wP5OtDFYRXULJmrog7DaUHQTVf2OJ6GeoMkyj53GyF3GkymKG89mpI5HA/pCDyCxen6c
wi2yMHBhhHjgU4gWSI2SNtRYcLX25y4R+V80mNrtZlpdW+15BqiznUlZ9LreFzibURR4WTOny63r
PzY0D6IPLDvJYuuujWuXVCW/+mjnBl7MObRVvSYSGa9J7V1841xQq84duoy+B6KHr3L71LsllxTR
QlW/ZvoWMs5NV25CKYixKSm7SD5oXKMgPAbogjy9FaZlVRKi4hEVnKc8F0VDuf/jTXGXxO0Fj/77
yIej3fgt1NNdGQRje2j1BEV0JjFAu+d2hqScDuEBsWQvidRLCWbjCxlNcBpG5FFO+NJSl77ovThH
HC16iSoCDEEDxYjTkmpvSYYN0F4wpw/3XJJfk8rRdiqGmhepgKpMPM9z8GqyFSdWf7fl8jZGgAKQ
sWL/mLk/0561lY66G6nH354sE5AWvt5OeXHAggSaTUTwaBjUvfpwHaGJx402y+miceA04ZLIcl4X
hh0Bg3zIWsiAvP8McpaX6UzUgeXA5w7jSPR2U6jtu4tmZFEA7w2bLnIKl3Le3tJhITciA/6Xmg7d
mgB62hAfaAwxNqWYo1X0oUXxwlBBd0Q+Y/zOdFqlAIbv7J4ZVLgE4mKTEBO+xNkyZqT/UlJ1DOb3
PCB1JtJ+rdC0WgSN5aPbLwBPxAfA7cn/jfpwLt58K9rvKelQQYdhVfP7TWPXKPs1Si18aKNbsTsX
+MQ9LkN/iKhkv0Wguv1A02laH9Oxo+ZrSFYx1tm4QwnvVQq0orTL5MwxWAQ+AJZFPIBmBFtROcuw
nRokn/Tq3Fv3tmj4I3nwGOXrO2D8alpEdEoHdAhFG+c1bjn87Fn+ypUlpW0pPaCFT31i+MkPLNze
MSL2B70AabQTfaZBAMwuDZe74RpsbFn2SDY/JEe2Gxsi93tG0rHENVcatsondBGiU9ilUdGs8RZ+
AMLFGxejLq+KWk7Eicl2uRVZOpyRwxouAGqYeEbf7/X34/FPho9SlVNfgA4lAzXPmdVTixMqLW7i
UAdodunZeg45Anpx4GDa1AMwiXLR3XxKJSKwYk/8Ze1bJAUXkDS9hV37B6CzvW+pQ+mlSjJ0JVi0
Bh7Q67iO0K1cd0NPGbDccPvMQ2ihUDppnmmyrgeWGHVWbsnwHQ3sAHhG3O8Dtc90XFbEhs/ZQWcx
3vN4+fZSrGcyBPxHi/MerGIQKHzv/WJKrUJA0yGaDo8hPNgPgzI387B4wLsoGsdjrHtSDcOEIk/W
JeWWiQwvgkVm3qr7H6CW9yNdI1PzHZlIkR6merDTD5yP7ibAjnSSuLHKwDMm8LYbtDi3aPiubAGC
YQVL9jAyVlRLF0UQ9keAFIZFjrW0vrvZi1UdrEyyc5vhWy4RmANHlafkDRqX9B25Rsjpz9u5WTgG
32iQGDpytATPyEw9opITF+CEHlwRT12NOMy9rwVMyHhA+XYDuwquMTTMHjhdgVsoClIokAM6ixha
JsdGdC4qWYI8l6CzED63Vv5w3b6+oPH2a3aTaQLWZk8rVFKYgDx7dVvHKzxiz8PohttkH92zGKSI
ykKZrFqgsjhqJ5PfSAIYYG2ED90Cfb/bLf7fsAOyu7nC3gxhh67cjrG/muzQ+42T+gpw95V8su42
0Ou3BQD61MrgrqcjYvMhzC+R8YFhcCpW/pzikD6EIEPqAWkop1xiV+qJCRNkCMcUtgnMyFGNdPp3
BM3uG0BTkTTCZCgAxV16HyPH6d1A3FFaaM1q6jmyNUYo4GQOJB6/dfeJRB1XeYw9gC6KqImG/o/k
MkIpLOHnVG+vKJUIT4os5KkL0FAbm734jVaI+SNGO8clyMYWpchZUcmCJEAkAJoqRQOBZyR2F7ok
5FdAmHui/RZWrA26NzAL2YHbCd/HNJkq5wNcSF1Myr1bl+eizWccgSb9u8C0C1fQ7CuhsxSxSsF2
xniU19Bwyfdstwp28x2lqmpwFS+m9Mit7WqjyJVkMP3bTCzqN5C998lhezrawk11ItOtyq8p4nTm
9raPlv7ZD/NLbAk/roZAAkwFaUiC7LEAA97PMZHiAd/29pyTOXndtIA5Nohz+2ZB5KQoe4aL4n7J
s66Zlw4AGJioEgGIWNDl2LprkeqOzSOJp2/Sr1iXFzWMJTzP6Lgl3bBg/8OiXKeCY9mYkrgopU8X
h4Bzq79DEEdoAV5acr+p2QGnUYH65VBN8zHGRXePK2oELs/lt5/jeAGlWcTPyk4pqwt0G8h6FK4H
XJMpcV4tIFPQeazJ/GYObY9CyDK07cMAfLhpY8xKWaSDc4GaBcSf5133w8aqSJBdxbag3MCdQF43
oKwc3bLkSfXO44WiM1BIGt9BoocSxQ05fBfCgvXYI+9sxJsE8fboI/aGayqoO5QDQ4EH7tVn8/wO
RsM/w8A21mFQ4K6SORR709afQ7IGsKCl4iDIil6TuVvzQxIntHJSU9ym/hcKD7EhU4MMU6Cet0pt
rkw2nxyzYdkPkGL6KlJ+K+MNgWVY0CYEwE7TuR8wR+V7hnWjBWOKIpLoReNDr3q4+h6AJacNFdYc
QH12p7TYEugGOYjrsA0avMG0Xhf54XLRfYd4yrsKSd7olN5UilOS9vWW7ftZtgN7jKdiOhBkgEWz
sCeQdAAYEaKGEZGtJ6A1pHYYiCps1UBFbdEdumDIK0SX2U+1jOsd6VJ0yOzSHQEoQPyO9akugr4/
dQV2uB09M3cbowC4bJs/QQm1Vym13S2YA36XpQWth9b6D83D6ehyAuWr5vn0SS0p8Nmv35irogrS
0OlTZFpHYHuRW4Pg7Xusl9lfwb2pxo5kNVK/zAm6CzyEZM2/EFHqcWSv72KjtBlzTqZyw5NwHNrE
4KXLX4c8BBSbyx+JpNHBeyePnSe/QWSN9YY1r3QFkhoLdH2U2I4gCwv4a5qNV5ppzo9LPq2fq2bY
J0EMX4YYY/FucOGA3ROvPHEFGNUBqJkcEvkXOW8o/EA571F32XDWIsTQkcHcjNUkGg/QfyRVn09x
hXFnWc9u38XbAJhkr+dIMqyZaDePTOsf/QoxTem5sTN+CaGbVAGgbqCaBfmxq2VoK9uP4xm2I/XT
GS0B40CA0zXUhHe2W3aB8VVuvLpCbcgC3qGKcMh6bDA7fcp01WejNcWUuLL2oZMz9tBl9U8ZgJ9z
qLR5R9s6fsl4R0ddg4Wsgxo93UkpZxaHNWFY8v8KwXJ2KtY8Y8ctV+g/XqbWpldEK62MnbbLmiT8
YpA593vYdAHgae4TaGbh3Kw2skt0Ia8et5LL/4Yh828Tz7oqQWDHTdRGV77apOm5C/CllHMgwk8D
UVzbmHlgX1MvAaJPLH4YUxo+8US2zWKKfrp40rMa/r39uSDbbkoow1B1isZjFC5i0YxLWQwUB6wG
E590G16WRK/85PCIfpKl5d99uqkmBjtegvz/4pR/exoBi/aMi0eKBtJSJ2igL2O2BjgTV1Z2InBI
Oc0NlrQum4+x3+IL6/vibUxFO1U0SLIfY6TyR26k3i5o3khvYDaEpH4IsBFxSX8lcgRIK1l2coHw
WOdROXq34YRBSj9P10sMR+opZKBaDSq6HsCZcziM4BP4oLMOKwwTG6vsoNuXaKbmNUGIy2PYu+GI
MvIe9dSjNCNIdrqfNWem3vHZoRw7GNeoQu83Fl0tklM0BRbgam6wN1H88xMOwTMboAoAjDcUlyWP
eLUMW7RUKUatj060OWosPZUPo2YaSLznfUV6v7CTi6YRuaNZsV0iNe51iwaQMUYCtgZyecw7ICfH
NE0k0nLA6ibN3gdJWs6x7t+puE5V7Mr2Ya+hp2XA9ziT2J4wpyOOIMxjfG3EkxjzkF2nFuKdPe+r
EETnMV3FA0q0fYNUb1u3LB+atN2vGDdXL4hNuqr98zHaSz3L/Gkv2MrugYAFF02jxQJwzZKXdWPd
MZZywXjfhagIkqt81a0ATErTlB8AQ7p60tjYcNYwRUvcyMX+AH0AXvTOEA8zQ7EDpaDzfLjGHMNq
4417sx1NLBabzHvQFMigonEy+GMCEhHM+MjGG9OCZSyl9HGl9VC8WAtmjc8xQOolwhFV5zsuNYXD
RtehnhLw7DNIERZP52lMyXJI+JhHz3aN11/BuHRPcKZRX2MzpNch0FBUPWxJ9zB1mIc0ihubAKwB
1EuBBVG+tGO8VX42O8c8oHgjdgi6RAyywDm9PwdSuxMpAmfKbGD49K0fN4hvwvg4Cw8HCxYnRIwm
ZCsF0nFraIXwlg0iMD1gA5iX6bB299pCKoCmjvaoe4Pfqw+Hu4iaj37bsh+ycISXnm5Yw2CCPmFU
2S+8kCys0oHvpIZVoIP3pRgN3gSgJizZ48898qLZ4+QuDwCs4bEfq37LuvsZGw02UdwlAD0snRtQ
KSh2gsTFo4UreSZSok8Jv8s7bclw6EENHCAbgOZkivyTDHd+2Lfkt+yIAfZrkMQ4T7pWTvPDiqcz
4fmLyKP25LwFfoOEoFu1m8Nslm/qQmwDSr5ksPe8KQy7TyIBJRdGyfocpzm4et4TimkQmeHdcWfD
5m+w8IKqCNA66m4kA4vUYA8AwlfawTiIBolNocFYRgwFpwKJa0szcOSZ4660XYT2C9puz1vU4U+y
fIZ1cx2nYHtD3JjvP/7zJ5J7wF2R7sPxjRXhbB9TqKlRA+EwbgI/nAfoh+Kwx18doNsVPVZDd1Uu
ojxqacBmkT9R2iqcGW1roWHaJWDzM6LN3GPUzWK68Rnex9L1BdRQocepXK46nd1PvNvJ/CvgDsog
QgP1I4/7YGl4IDn6SfGyoH0Q9JCrNj2q7KKsxkm3J4q0l//oSYZC0PSkV0wENXVIIKltiCJ0WUWZ
GG1XgtAiuCx6LI7PkehnTJ5jm5sq+bcYKXQEGemSKQ7x2lWe14xRDhWZpKgXLqPC+fUcgFieHyTu
pPihDSgHl7bCwfljRd/0OZ8NPgbIk0Jg0Dni10sUel2RcTZCaa5JWLbghm43k2XfEwZyYB6RK04s
CXCKssJQ/G96n8BMBppEof1y2TXgP6gW4/t2XcJnTnBDQiHGtzOWhDEqFRI1vqPBbK/YJu8MWBUQ
QWsvtmZZSAyZHGwMx0SP4adCEcOz3kx33wncfS3Gltepm/pzmmHCtfnO7yPt4KTgGK9z1Q1/lEt7
BOx3kbHlNmEclywKz51V/gA1QPq1rVn/a8Jk+7bKDiu6jul19UQ6LgUvtqe/NhGLx9a2w0NKU4aR
z4tLL+LtnljpQdcb98G28aDaPFrLKcXrUYL8HE/zGjzzqX/cAwK6n0ZiPmPfQbYqlNnqPUbgopEA
h7vUoQ/DABF2Pk0eDHJkm8VHQIbE8gnvQXukVuavW2LTOqC2f/XbRt5BdscNls4UihSqTh2myp8r
zBDNgAJWsP1RNtU4OfVtbHJomGLS3XRdMN1Jh8W9m4rnntMQ3AEUaLkzyw8gtF/DusrL3A/97YA3
+weXHOku2XALieqnbtnOmhQzXqX3eKhTFMSVm4M8jnSIVt53DGnhekWvC3Uhg4jqAhLtQ2aH+FbE
cql4WKAxGZEW7j9u6v/XnpW77nuZ9PTX/NO08r/4XP6/crZAm/y/cbZ8CRwA2nz9ww6Df+k/3haa
/SsCfEmiKEcTcAjN/P/wthB4W5IkpmmeRkmYZ9dczf/2tqTRv0LASIgnjSMCHfTV9vLf3paE/IvA
qBvhD9EvEuFv/L/xtvwjeoUUeYqfoMCWCS8NaKF/lp4lkkeeQQINiV0KgyTtYX5NQQneziNAejNP
GJ9DWBwasWG77K8qkBxZV026tagd5yR+w2HoGka1aAon1VmHkhF4T3qgEgNw/E+/xuID/8z2QAO2
n3Yyhz9EWMS/2CZIGSVeQmMRmcqybWkS9n8M5Yyjf0u1/6eaHL8khVcmSkkcQ+cdpv+U7EPvE9Jd
uOgYb1DORJ1Wb/hw6XpxFLnyhzaEoKiFkcgjbpQYexhUi5l/HBu3++Eb+R0jlAlh8rTm+3bMXUHf
C76zF5gD9Ar8Y0sA82U8P6Bclz3xqYhPW5zYpxyBnVdYIluiGnsHh+RkdxY4siO/2hYiL+i+lK2Y
a28hqASy2I74QGIw5pIvv0jqzMmhuf6AsTb/csNVtRSYLYoOdoadG7oGEF8rNjKki4Bt2zPoKyoS
yfGPS/Pur5kgADkbJqPl6De2TIDNACinBvTaQovhVm0tu4sC6DhHxHjjwO5j9ZBguDNI/VfzdwGK
6KWfCKydazSjy6Efi09It8aGwiJdQ3VdgE03SJiBNCpdWePa3ka1SjP6FmxWf6bDFotDP+xKQ/oi
NMTZbRhXu6OQnG0C8JYHL1xBB1+gJQfjWUO9zO/yCbU/FKNxY0mI+26FvSfJsXmrxQenfurFo8/7
6dgCqznIMBR/c6SsNWjXbO/zVoBPTVm83mYrAJvYJEENj4y7i4pWvQ60Cw7bHi6oMOj7x20aurrX
djzMk02g5NncD5N1iET0zsrfDkPf596y6AKCJb2zFmIoL5L5PV1ldEgy0L6mFVe2akfmkA9zWgKj
DA9dCoMsakfU/Bv7YvYAkPuKNDML3papDrjfxOoBDtIJfO1yE8Bzdq9WPR390Lo6X2Nz6FSnv0xe
1Gpd7otwaaI03atRbtNpTJAjTPJwfjIqTqDwmF0N8W6VoZb0N04iqDvp1EMyE7EDH0OEZwUSgDFM
amcxDtF7nufooIS+8Yikc1uJIZQ/kRdMnzSmmL9XUcMAjYTvXtTOr8Wynces1qWmVpG3tyD78vVm
nEL/g/ZmL8MdGrqyw5oMCTnKIJokaeVBjgwnwe7PexqjZse2twsDH4434deMF7ck0osKNZ60Si13
ZRTAVkeC/E+SmzsulgrC7anJLACSDJBUptn8wGzfKERCYShaxeOWQ5pF4Eu9zA5wLiPLkfP2Bgp3
eGZTBbZp/w2d+xn8JAT3ar0FiC4PowTQwRDz08cY3v1sPzb0wrdF/L0MIq6TkP0JopdZBfc7RJ5y
QJwBMOMnN3Tvk/GvC1lu2i55DRh/QXT6c8znkwAOXySyzlERS9buLiFQsrdgPjGbcIhF8TL1I8W5
tryO4/IViO19wayJvrp2LK8UYc8i4EpvvoAIu7e/eJK+8j7+6QFO3ZGATA/BAqFHlxm0IMTiN+L0
QZ4Z5+6VCW57D/0ySJFIg5HaMDsvfyQAxXJIgxsF5xToUSjNkUAE7ke/hsXY4ESqkhZb9L5CL4Gm
7lvTDRjJxfKa+uEWqpgyCV0D3V3J9uwUzht6dDA5QsHZVQs3CbQ2yfdAACEHipi7FXmHZ/As/WnM
x9e0b7ObxWXgzrmYvxMejOiZZP3BRRnU3v4hMtNnIHj+JyigEyVLhqKV7RVrVdqEmZleosw28Tiw
Dyi9sEzaokrAus8Dv7FYwlKBWCtjjiRam4nkyKTCgTn0IdCrnxmq5xCKxirWiz9jPD8LtGRBnI/j
3ZB7vw3YNToQxqB36ZWsy+95x19FAo++7MffbY+/383xXKq4vTN0LVMDeatYt2cK/QNEisfr1n6d
BGHy7G4GC5UpDyFnDx+cC++oWkqfW0zrQ3CHZCzb+E494cut3ZKfgMyrQ+goBzumn80O4DvEsKon
DbcPb6bAgCpv93OQdnfzkjXZFFVZl88VLRxMdPN+H+Ok2sT0hKr7FdschFgx9HxA5z5ZRz5jpe7S
At9VtyQfwuQNdtmnlUsodaOnaIVoPUQG1UIg4AUIfSsC6Nxla6HgVyCCmIP8WHQPIgke8FK/BFoh
CAJ/GyNEQ155jmCSKacRrpzcQSe9x7IxNoNMF62CnVIPm7W3Klh/qG28b+GMAfn+ZVA3vHnnqpYX
9OjD7rLnOoAtRB9hm7xDSKzB40qe2bpeBoj9oMfBbhS8Z8l4i6TgUnBA2lzaJ4iWcatNEDhS32hu
QhAqyXljSL0GSVOGEKtEdCiH1jSjcyeTvcUGGxLWXpChbi2abJldCZlkezLRcutkducUEcdU/cH7
xZHZ3EFomjh6aSFIq9Cm1zccB/xtQXh0O895f+xD7U05xeH4OE7Gve45CW5Gkj5D28TKQqaQWMHt
Uu4i8aAkhn87G/DQBLLAYx3i9qN4RpnJT2IHbamRxAFbf5jcdOHojyhDjUq9ots2+VIbEbVPEZuQ
Id+zgt2VVkA1+ksHMxFlPsDzAhBRd2I8WMA0LwGg9qshw+1fliLhf5LvkSEP6J9O3h0dXH7r2/wt
nzQw4uFgN8gGCL3JoTAbhqzRhThIcmVjhLvLk1szv+cKcgib4tvRQfcow+urHJfr5O8RQFgjmuud
BvQt9XO1WwQDQsrwI5YcsZEtR4S3VJAFulE+mGECn5zon5Qsj7uDBGn0qvJQEzDIwcQenWhk3vO5
LfD8iS+4XnBYIfzGaPV7juBqo7S3JaiUuVwyaOmoSn/bkb5NfkhLlSlbazX8gvOjKkxg6g66jEob
d4YAleE5wsKHSfJlZfFZBUgrmBGf2asXLvjboLtLG6QVdKmAg8dHR7PhflxeVugaBidqJwvMKQ4Q
6fjq5xXSFpAceECKI8SYNz1El7i+5hu0r0AY3mZv+Il/FMhosO0EsCo89Jvh+GzCT8dd3XfAL3rz
F0Xcd4VBS20qj8VS/HCie1ZBgF8rb9CVmh1bZp5Rnamg+JzTCj1mP3k+aOy5AL9JQG8Y9ZcIinUt
IbtTBg+8RzM3lDrhaeYQPyw7KlFDXu9AEdlVlz7JrILF6lbDd1HDhbZXCg9qmW7nzkEPPYv5VuTr
VlocXGSGcItgwgcmvjzGkLUuwCQqJIB1R6aWtQ4E1D3Ku6Qx7gWOrriKt1bhP0gOkNFfrhqjbiUQ
f2RgiMXaPYNdsnWXb+oUtgw/NegJq6FsjTcLPw7cDyCP00MKFQ3aC0MM/ynKfdAa++ayGWrT4b+Y
O48du5FsXb/KwZ2zwaALcnAm2yd3eitpQkjKFL0Lej79/XY3Th+Jt1RCc3SBGgmoSO5gxOIyv1GH
rhP7we72otGzo1sG4D0N0dBnDZGMbYRxisHBIpeUevt8ij61ojpGGWaFWfFgRWRiA4Fk07Xyi6fo
j6gx2jmTiWtv5dG1IKvY9U5cH2Cbs8lx+C0NKnvjZARIIYy9V4NZl67+iqrCQzDPN8Kyh12J3PgW
pAl7XwcfY2XvtHx6KGn4byoltWOmJfADDDZ4JBQmO5uQFE3FJ8yyYn8wybs5W2dhT81rTsZ2ClGl
COJY3/ZKAaQGLMqcG+/46IfwkktvRL2mWneP+vurZbmnMCi2QXgRBDHSLT7YADpSGgnRACPXk3cj
k7WyjNKrSWuZstg6IgUOA0WGOcZISqsburfVadsxTEIkMMmcfFMytqEpDjeoDNQDFMLXpI1OOvEZ
AYit7dRwm5h3hvINMmxNaOvNY2SMzOlLgCJj+iJnnfFKNe5TyF6kVO2rk003ljHQW59P4DreHKQj
89y+NzrvFNfjyzCCP0q0Y9nagJrOYdgkh76ZkMQe5vPcj+fY1D/qhj57yEiSlOxsBO1nsyG7gSV1
njEb3jY2UIG6pnff2M3Xqgv2UvEMfQ1Go1PTFyhndE2S+SvP+tUdwk9Wo9/WcQR3qLTyjWFq9DeL
/pubZw/mBASsscedRsjcJY59gavYYQvylO5cKI3Y1+gPBm541VriOtZ1TIFqAODjddHoxdaqw+cC
/OCxsuNxkw7pJlKq3mC8cpOEWN5UwA1Curjk0N3WyQmuIdxY8xHEq6+ksxMOSKUu6cD54a06bkDz
EuiTZzNtO1wRwJ/Y5g+hQ2jK+2uIVXsadc+g0ac9M5mjWcavylSPWQoDLibkdpe2eFP3G0trD0M6
9scuKaPnzAz1YtcAtGIe73jlafC41xsgy9SJufsJG70GGFuXHulrD4eyR4ezsHvnoSbb3qtRqmwb
lGK8wjUFT9ZI5gcDMPURiLX5AVTEeHPLiEG0GOR8KsrwJCPwpC0lxCYZGWwJ3GjuEiybQdWUNZOW
sdE1bAK94LudOeYn3e4ZB5JdMDqvqiC+p5DCVaYYa4rXBpTUNkO/GzKka5vPNASp4hhMwU0bhfmR
UmAQM2JMuUkW1I/BYc5FqGeuTVkurkpLq/dDVWGjZ9dKuxtVn72XoDvOTEK0kyZca5/2yXDFYLI7
QXDRbmXnWIDEi5QpFvCGR5on5gHAE9liWRfOpxhoxNZOHRD3uRgA6wOoPRReAw9GuvW7Tay/LnEo
sjeaZwQvjqr778YcTL7bpljJGQ5KWNkMGlnPphFWkt6n20hK5nqDKE5GXARPSVu6h9jTzFMH4frd
GGeYOfBk8IU0tSF3T7GexwQ0rGqQei/HH20aaXeM5Y2NIQNglNOwh1qUHyernhThTjnvQWeN96QT
3WWuGlm3oYbk94ZyxfbHNCZagd19blMHNpRw2lOLHPvrUGviK5541Rag9sdcePJpLuZ2z1QNIFY9
hretiRpVlL66sV5tcDTUj2PTVBo85NLYm2VU3mgePFEFm4/CCkZ90uB/2AkNfozNoJvswtGe2jCB
0h/U6bAV1JTALtDzAl/WGdERz2H1csEEfOAu1n9JnNG8UijdHlQ+kSlbtXYzd6CL9KDjUxgMrR95
ojzgs8Q4mtr+CEkq+poR0UHlYyAA1aHP5Kl3ZXqfNjJBYs5uzgyux8M0QJdUgw2YSFTjaXCDYMO9
Kd/qMB++Aq19a0bOPZPokBLqWCjTnjZd6MTfdDMhrlaNF6UUSR1MWksPEClIFcO7sc9okDBI/G5F
ZXK2SmsYNpVJ0qhLYe0SQ8pNYibBvaN38wXQWfl909c3teWkO5c6n8cenxOncI5KwO2UoasYN9m3
tUkJVzaghXNjvIVQ5XCttUGeGjhr59IZysPcNPM3zdKQCLMY1ZcIrwJpTrKHGg2Sz4mBECHYJaaj
AJUfm0DkN3DjJ8rkREYvHuHjpKYYvkfr1Im+nZyIWeTUSEouad+O6UB73gys/ICcQ7HDNQvenqH1
m1LGxkce28lnKgf3vQsZBUzBEFzjW1Nv6jCa3tLJCJ+DQTL5TG15Z7WDu4cXifiV2YJP6KHuz4bK
NCIDlnMhlaQfFHl8p8uUqD3azUGpMXlDc624Tw09v5Ohjcgx/fM7q5TDQ9oM/XUk5/lLKvjSOVFn
P0TCBd+Viuls9ReaSznNX/g+WGTGbuHs0tLqLlSXtuAbmsU3FdBOAyJ3Wbx3TUUKSc56jeBCcW97
lYW9hWm8XCgGm8hoq/OFUP6sy4avDAVe06A8EGrbfsbh1rEt4wD4GgCp3vRnipT4ypOVc0edATc6
0+ZdblvR1p1147kCnXyKgjIBImI3e2f0klM3uR2Ugrort60uQNj1UwqiStP3zQXeHkqWbss2AI0J
D8aVev42ucF8hilr7oWtBWdptHfVkD85qM4cvaAfyXFIKoyY5o3qcutplk2/NSDLAHGzbQriC1fJ
Apn6KZrnbuMB4TmrsmhfqlG3QFRAz8UoOHqaOxc+guGQQLrg9SSzN/oGziSeA01HnMIrAWoB77Hl
vaZr9YMqStCGKkw/pS2ohEORlPKm414eyqgGOJq3nXZbgraKTujqpvCU2ojbLcv8MqgPz3mqsPwY
RqW1N1MJgGjT1hMTOxtuD0NsVbTPMLHSlzjIGmszeV52V9tTgft6fCkBTS6kIQv61phaQNsAiuY8
uheJ2LyaoU5KS+6iBHixhBFxl5Gd2GjXlXKrTIFJm4cn2cZVuEYqhp7x1hmnei+DMvNhylTfxVyJ
KzNCiYPOZnmHvAofBU1tRW+kt0UKKho4qHhz27a7LzAnjhnZVcaNAl946Jzkc5zliCSm1hw8pf1c
HBH5aj4ZuWZ+12LdOZYqnq4EDP5vY5oH3wejMr51sW48VW6s+Q5jZRCI3gzQztU8yPgObdnqUGfx
+Co9Rm/gF4jItDoUJ3wQ7k1nddSUCL8yA5+YxOMxFJZfG6B63wJBF3Of4ONy6r2wBLAStwG13gU3
FqWZh1q7Nh/aUTbxPQhLj46SRPZjpySAmn0/dVRuGUPTKwtdQlLQsKlI6uOw21MDm0+uMQ7HQZvs
+wg6zTPDB5KAGpjwddHFxmGQJI6MtL0MspVQyUn1eI44dSr3bWaKw0xfHNJBV48EjKrq/RkjSJJa
K0JyowHDYex7+jTnAbvV09iBn8zAFhyBHlhfgjY1PuOK2B3Z7cK34N8iPwBrhQajM+XvoQDPNGJZ
cTdUifWqkaDc2UioiE3M+lvsvlw8IhOCvKgq86WpaRsfPFhHz1XGnHqI4rrc5nMCCjmBXMSkDtW8
UDuKQlhXELoI91Nlq6c6y/o9kyN4pFAapzs1V9pNXDjj99CMDNpVc/kUj1WJ6MgYGrcdwla41OXG
rhhkk27DHN2hKsugroyeVmAJgPbIc41p2JWuZ92LMbU4woxEpI1LF/WTm3TvIaZYJd9cj6YxEAeY
1861phlbUHnwdor7IAwrtCf0eY/BH+WEqJpj3Z3C0RqZa5daSuc90G9Tp5Jna9TBeSLJo65rJQyU
IBudNypAaXImyq1ej9ZOT2j8EMHew66iE10K88a0R/XcVHX1UsJfsbeRNsz+3NKFA9kUa3uR0sRy
O9B1yHdZwGBkIOmtRb1xKIZyBoEEv/6irr8plE1iO6cM7+kJv1DUBefe6cszBaY6GCjEPA2eJvwR
xragsWHaD3TNSt+sTOTtUwupHg+CS4YrNvUcLjFb0eScCpOWZFTV8iksg5CcX4u756o0nTdVas6x
4ze92oNdnNph3OYZepfYyoTR12CONO2mHCB03tiAsGaUaJJPINOLfeTVahdlTJ5gacfeJcEABNwT
Q+y9ijvjaNLoHl+7rnbuKDFEcTMZtmHugnma0/1cBeMhH4g6dxaOVHegUMDZmmmRIqeglepzU9rJ
d9pVGaV8EUXn+AK5MxLNfegygG9ZUxXf56QqfuTQTA6kIt3LkFfcicyzPvdNF/dM/0qsCYE7nkaA
jVd1KGjAgnzQbhChye4aJte3gVXijmonsDZiK7or7dq8rgGubJSO1lqa6dUdXSZOVusZX2M3MVAR
byeSPMOy230a9v0LbbEmBQwdNvsQn6UtZE1rT32YH8DURlcxUemckvO8cD7em8IhMaC7dAwSr33U
Wq99npue5gtW1dVDTqiJdmI2OQqw7YsHF5GTa52G5U4UJMx9qWBQNnnxzvCgPg7FhCqFnYlpr3Ua
d6epO7ztLDXk1xmMPBiE3YPq6H4Je8ieW/jsezQxDJ9pILRtFKGzPToC5UuUdvJAsFNHy3PrHaKm
cJ/sNgy/2YNrZHsj5vMg+nrfOXSNygt8h/dqUpJV7YccGO23rabfO94437a6NA4iMgyg6053g34O
xZMlcYamPLDJ1eqSZGpQ90EAAi/R52c85p5VEoyPuazyPUy6dgQ0rUPaHrlUhxAS7AuoG8ehqBiG
bhPbuSK3Brqq4PNhEjXPDEIRsYD3VbrVo+LjB69Fql2GovOXPHabLwSZ4dpypvlGTwLzHFHXXMeF
Nb+EhlltcGuovqSRMj4hDAjjjdHftywpxXMRNO8wMmjOllFwqGipXBsWozPQWWbWb3kT87br8/4M
6Ce/6xHH+oqM12k23dE3FM+apWUHL79v6isa0eO9U7i4WYKtvGRbdQwPMlJJfh1QYc0I4Nwntk4E
svLqnOsSihwQ1nbPZ6z6rhVO/0IUotlBiXqktCK7MubzJNxyp5thQfvPfE+zKYOBnxsRQ5HUVPlW
jVMMLDBuDw4SP+mGZKV81ZQlPhwAdoCeGdCNQTYdKG+HGzXD0U0u8lwAMZE0UsY5k4nimDhvpqXk
STN78zClIriPh7oi842t4FibmtZupa3ntx0aMKA8tdssrp3voaN/RVsyevVK+l4KNJqdI69iQ/PZ
UXIxWk89cqUmeivTDq0KF4U0QJVg6TYOL5uWN3TMZCbpcitTB8DlviIJgKBIOgMsb5Ot7LsrUy8V
aLbiZsgEeFNNe+wbZZ77lH4c5e+wiYJL/d6JO3iQ01uRMEYZSbzAPPOzJbPSHYRytrpTR6kG52k0
wqvKBGzJIH6mEp23ZZTsDJm/hIF6qbMZUq816VckGf5kgt3q28uzZ632ECbuXZZUtwMcOnq212ap
fwmK4uzW6Lob2dUovMdkLB6SAd5JMudshQlHxAsewk7JV2EiCh4VfbANXQ3FX+VcJWSezkYfRv2N
tBNWrgYMu2gfBwcqVI+19UFp4zPFBmV9Vh6dgYw6w3nyO2Sg2p+TCYCs4agexCGp4DdgsBeGZehJ
hGPj8thYdp5tShLf6kAvbPJHDSM9GInV20DoO86RXW3n2DXfvDhtt2E0g9nxikurqRoeIe7b+YXG
yPAT4jLN7CY1QbBOyXMzQWCkFR8kWHoPBc2NIb9qS5vpr+vmX5htU1NnjTrUps3sp3MYvI/WrU5t
CW5xqk4edVu3KUzjR1KN/AgdB+5NOUNUGEyNKNlE2QO4DOuWkpRmL74CcFudYL7tiYXHESlcPlj9
W9JB3YGMHezmtKWVT2V+ZYxR8KrXjjg4g8fAEBg1RQPCcEjXGEgabDBPHA6iKfhIgfKrHsIStPZJ
N5hUqVqlbFLJTG0Ap5u4ybwfTQ96vXMZy25FOLS0l/VWvbiuiXRzP6fnyWyma6pFa19NdEULSuVs
g9dp98ljbPielhH9sakO2y/6ZJePQPNHRkUCui1aSmdawYW+s+0S6aMZgSuuRVTc6JqGVkELg5RP
9fACAU9dN+Buvjpa19DjI8vwtrZom/e6akcfs6/oDSHc5jwC4GLOO2Hz6TFjPiLV0ZuQlB2qzT4G
gF9leghgECxMvoW8w/d2jrOs2+pkHTRYpkE80XvrX7qiT2YK69wx943lFdfTKLRyH7ajEfiIKGhw
hGdL5QfG9wUsYWawTyAxE9gc0rqR7pAy68dLU5ugTVpyFI+MDGvaCcWMSH0Ms9UxgH8PVpj7gR5X
2XYyBWTg1E6oqiYj3qep5b7akZwKLEWbkhtTROVrNjvpoS8JxH1dFw9iFMKGb44IijF74oaE0bqi
ca1FeE6VcBO9UidBi/RJeYc8G5w93dsSUJAFdiDzDLVzoA74eiWfs8ylQWVHYXKrqEvPgNnjA+pz
zKGobuOptfjAQjNzglT+MFQa38+ZPTDaVZV5Z3ZcwG2PGwbn0cnOshAx86K2vktggr4xdOsvlBJt
56SxseWLze9jnsjUn58XD1b/gCo8A+QorDXQ0cP0XNhd+eKgHXaaAFNssJ9uD7NjB7e6CJAsix4i
o/xiFvGbXTt0JTB4gZKp90+5mMuTTu76yboYRSN13u7IvfovTaQZ8PYS7boqGnQwUahztlXlZfdg
B+OnCXjpA3jJb0ZM125Pu6+i+ZTauoXkBrRPiHoJ0y7NKcpHQar5WBSpc19bqdxJOBRyC/nI+z5c
mB/JVPaMvRFZLSZimFbr2g84CGDX7SR6zalCD4QD8ypUlr5Nw9yElmjOEVNR4dx4TRmBPICsV3WY
DzSVEt8qLUDHprfta52ZgQ+ns7id8tq9YlQYHuCQfouC6ikL9BJaBfUi3VX+Rn05S1Bk+P1oFBC+
EEK2lJvvlfB+NOk8PydGZCB/Fn+YVd2cNZlleyrw6Qa9pOSOrrH7zMQceKrbdQ8TU52bOEtpfwbY
AI8dk7FNpKfek6nJ2tp0MvG+UuBTPtVUv7AGc+dhNAp6TggXKJSrEgpL6U7FKRpSF9aXa39w/C+M
ltZ6bcIiPFHkR7SaNO9APXrykng+dXaOFo1bOvLQayCyTa9guJZVArGCiHGQ3SqA+S4yyreF1wbI
B3bOg95fZpgUdpBH81hu49RMhk2GSAE+m51xcV4SoX1FE0vc54Vb3ndJ1N1C7i1vkiEyB/ijzPaR
sxZX1PhMGIaUZlVWNz9yPY7eOs3G/IgdRFbJGzR3X2b5y0zn641uHK2zurSuQ0pK9O2qel8OoIKy
kLYKw06JCAae3MkA16KCt7x1W+hPQW1VOwV6eTMbaXHdz2VwlXkZE0lDEWU9CT8bauGtOaH0V7ct
SL+8EP0mRQkNFEjOoMIgkRvmGkGV2nswIwuBRi8zH8sqnW6QNJbboXLrVznsayAJ26Bq750AjloH
SAHqmL6tgDTty05aKJA5vUdLDST8JT0Bgz3TZekmfUQuwJTxObP67Oz07QSsP05AMFxKZuSZ0DCx
Rl+hmfFGbxFkDJzcEoTTGZUudSdkFR+pbNOXeTbbu8lGy2+c9PyzoMo7huVcfwoghb05sea8W7m6
5BOwsgCmQVUbIbYXkcheVFW+DOjqj9QRd+7U1L6e9/K202eNPa6tG8Nqx0MXd/V5akrtyEge0g+U
4Xt6/vxWYaKzuaNtpF/RVw5gm+jjMU31CiUMgFfHprSar2DKjZn5vRe8R2EkT8Ks8a810ZpEdCNN
npCyZGQJ/nC4YYoxnLxW5B1HWw3XRmiM4Rb+QIbOkheb7zqAux0t/huvzy36LVYoQT7Qq6mMy9xc
g3Xgdz3JZdtc6EiDXaG9ypjrWQjAApZW7Hv4lt/SfLwEVD0e30uwOvewoxEGQQoC5R3YlDWyG/oG
+OMHuqjaNpqn516fQLSI3ufvmOeU/to+iOCII+tZ1l8aMCvHAJgnjU/LiB7Tpt16FM17wbj4ZkR3
zN0huWe/23HEHN8mn7ulp5bcYo477tHarvHQUld1JmcmGyQ9TMgta4RiGVpM6zVXoEOp2VrzB5Xj
ha74BSFKl103MdVEgd41jIv28k865ggqjzHhKD51AVYLg6YKrJASuCckI4Z3AJCi9hb4gn1JrXbt
ul0UbjoFCu8PrjC/ig7zHK5toXSPrrvOTE/qC7nlOBbhiPoG4pfRCK0vitp9bDbJv9SN/yMs9131
UTy16uOjvfla/S1Y+7eQ7v8ffQhs5M5/j9Z+jT/a4mv+iw3B5f/4HxsCD0sBT/AKUALCjJlT8C8b
AqEb/wBh6Vi2g+S3kB4y2f9jQ2D+w3QRWuc/OhhCSOPfUG33Hxb/Bkqb4Y1nWyzyn0C1fz0amiEs
aQEENxdHk8kjTPqsHJl8OLtJQqw3Tz/twV8YCfxu5Yu4/0+HfowdobIqG/yoHb6bafodDvQfNMt/
t/Tl339aukpGDeHLYvTbRM70lsVjirjPH0TCf7f4xerjp8U9z/GyMUsGX9Jh241lfpelgXlYtym8
zl8Wr7TUHQzEFmzZXXsIBWznzPuTqvrvnnyhze8iqANHlycn8wgO8CkLRrResVv36IvgMRatqddG
0/uApJgmuoB6dAxO/hArf/PsxsUO4KddD+MIYCEvkTKl7vdOpYKzl07Dumf/J0/hp9WnYIopRJ3O
T90KhmZGt1T+4Y3CmfhJU/7fF+jiVPLzgw9p3DMCmZCpMErdOKEb3jTH2YDQ9ZVKcx633RSASNKC
XjtbfKJWvmyx+Lu03pXRqqClJWRDt4MRAK5+Wrdfl1D1849yskBkU2C1vtPHwPTyvL5RtvUffY3+
vWNiERjgaQNxNYqOdoB3Eyi99FNAoiss44hn/zSW+ulNu2iLM6PWW1/LRzo7WdQ9a1q+LqQtv+Oj
C82jmFCvQyHqI2IyIMrmfdXtuvB4ft5xw8iR7MpNhPFERfOJxDmjVT2Hw92q9cXl+P68L11PW9OL
Oh91U1TM2rI+ii76k7/U727v5d9/Wt3jIMqkrdiYVrtphLNvxv551YMbi3AsOozHpJCdX0v61wja
quLeQsxo3b4Yi4CMNJ8uO2BIPgCC5FHHWeU0CTjH6x5+EZFDdK0indaUX9doyzFsgJkRzA/rFl8E
5KqaQ2cOeXSFeUm9mwJRfYOolH79++Uvd/1/6U3/e00XEZluLyoTOgHGCDGEg1Y7BH5n5vljPXsI
JgZ2rF/9/V/6zekRi1eMoKkpgdoRbZAaPAu30JFOpDO+bvXFG47xskD9wWz9AuRXDO07ju/GGB3C
3br1F+94AAUxNDoRp2iUse8SyXCi/pMh3++2ZvGOM82TyFrkLXwLx/tMg3H6BJ/Y+MO36zer64tX
DHMWy6mUV4wGIno/nqLBX9T3f78vlw/RX5wffRFxjKymIR3Kxk+UPfyosSo8F9UMRAOZHQSDu2C6
uDmY9ve//3N//Vukt/hzemSoKVet8hlP35hZ01JBZS/r1l58a60wpM0uJ+UjA3pwYFFNsKLWLb34
0qIJZ1ipNip/Lpo3mnF7yBr+uqUXn5SyqkqEE3jqNhI3eZsdE2Wt+hDKC7f053hvR3RoAlrZzLmN
9yGdrtGVWvXUrr7YawT8gedafEpoWFxFY/RjnBNvXSiA3PrLY6vYCFFjJ63J3OFseu6zZVRPazbb
1RebPXRDoqrKbX2vj64Tvb+a8vC4bunFZuMsUbB2SPLqMDnJO+2zjWjFyi1ZxN5IemWP1VOLXDIy
kbNAh6gE9PO27tEXsbcTQcZQEBVhD6BtAKsI6uC6lRdR16bDluqtAb8xsWgpDrsglquupLvskhRC
mkZUaMpHXOoO7Y6X0hWrXiXWU78eQHhqMFWrmadutXKT685zNIKmXrMl0lu8SvRvwPNnsfJFykQK
fmAIp3/d0ov3iFp+gCxpoSCKlF890eJJHq/LkeiM/Lon0G4Z3sED8cfIknvEHepjB1R8v+7JFx/Q
imZcBIILZy273lqouaGQsS4IuouXiUqqiy5jqnyMqeUOjZB3T84/Vj32haH/S4DFSLs1HY63MM0v
0VQ+JKVa9dHHce7XpS/IdCe98APYm00QftAnXHcA3UV4rVAAaNzLXkfavCnN7zQL1r1FdxFd3UYy
aan4uCM59B51ESrZQ/Nt3VYvwusEzjPpoM8gFc4MuM27j0BYq6KUdBdX0qVxHtdZ0vhyYownxT7N
+nWhxF1cSaepkCRAJ9ZnVHPfK+dTkEMB+fstubyw/zd1Y2L06xGpXA2JXhh0/tiV4CS6OmOU5GV5
/ZHnhp0DC3bVqnodtYpf/5SLuyj+dLbyPRlCLkGm0zu0UTA6f/gpl7f4Vz9lcf+nwspHXbB+P403
dmN8kYb9+Pe79Jul5eL+e2GKSXXDy20qEL9eBUxB0yyx7jItDQLDhhn4CKXUB2YLIb+5m/pmVfsU
C8Rf93yYPSvxcj5w83RxR8hhFQFKrNbt+NI0s0xGFBexE/AnYHBh1IHez9aFAbkIA7lni3DGAsyv
pI4AlGehT1sar+te5yIOkAh1jdMRF5Ew2DbjE0nWbt3KiyjQeLOWeurCyALLUcMEBI6+buVFEAj1
HmMRxNHxbYKY0TryGbh6+IcTeNnVv7g6chEF9B56nDMOjR+IGkE+CZ/Eeyycwi5fgw4VjlU/wVoe
xlINwdgyE3Vz+NZ5THxHNOwPP+F3V3Rx+z1VgyRM2PlkDE8pkmi1G6x7qc7i9hsR0puIh0LV7etd
P2IERxK6akucRUxMG4IubGXGxM17o6tNkqw74s5ir/XZaTAC45mtJr8GBXKCXv8nE+XfbLWz+PjD
Pept/FzZ6iKCH9tjpZYmK/NPZ3HxC+hMsNLJESVOT6d6ks1uKhNj3afUufykn7qXHXjX4IKz9V0g
B1lnblLktda9ysXV14x+HJDsqX30bg9djXzvGFytW3px99lckL2Su98WNgA981pQZ61benHz0wY9
RFQM2BA0djHL8XRn5X4sLqTAuwKdOra6GYxd5cJqZPK/6qHt5YWUZmiiHl/7Zo7H2Ih2g/xTPvSb
s20vLqTeEe4qCgi/y9LdiLqLDMXKp15cyRp7OVSvOCAwBradkV0jCbPugNiLGxkjd18kjlnDME6M
R8vspo0yE2Pl6osrKRjOXczsiSUmhiNCyefG+1MP6PLj/+LLYy8upBwb9Iw6up6yz5z6YHUMioAy
Agy3Rum99zOayFs4YvmfkBq/e8GLa6pm5CVwuOEuOWI3WA3UJLj6687l8p4GNdiqaVA+ZCwkPwPX
Q5kkWdlRuMANfo5ddYfJqHLj2h/Gyc/d+irD3HPdgy/u6pQIXSJgU198WB70wnjyYudfsn+o8YUf
5f2/XuV/FV1+j+Nn2/z3//nNfluLu5qr2BNdKtjvufYdOD6I9x9WPbW1PPXAE23NS2tfzIm1BSPd
7GRu2rt1qy9OvRKyDtA8qH17DgC8I+qGts26Rh/Qo1/fpdUhryEjTmHZuL7tcdydEcbZuidfHHGK
/dTAtZFCC7qjgS+QUuIIXA+M7ro/sDjnHfhfK8lJ5ChdUJUxEfA3Vy69OORaADx3TjiJKGdumVjc
t3W/LoxZi0MedFUSTl5Ssy31ORlxrLL1/aoNMReHHAMtXFFbTmKj6TvPAfNa5A/rll58kEZNIJKt
58of7CbbhlVW4ZeQGcX3dcsvPkoJYAw7AEtMTh6LxzGyx1ODNNvHutUXN9Q1Ai9Hv4ucKDE+EhXh
GgSIdN3ai/s5za1jdHid+GkTgLtXt03crV17cT3BFGow7ziFmfI+8C7eVgao3nXPvbidet85peXw
QktNh1jqjV4FEhKj637liVnczrp1B9wuCFwp9nIb0efHvklWHpfF9Yw1JMFFyR1ymuF2zuHj1s4q
rIg0F9cTfeMsjHBJ9y3NeFO2C+z0T6n55Rr+RZKxRBxFJvoaQaWoyrOpsR9E3dbJwYUMgJp5J3qo
wtFsvyI1JHFotYF77yKzgVq/6oUvEUmgDczMzcrah7X1A9uaeYv0+jowlVxikrQkUS161JcxA3pE
BYTx6AKHXvfky+vraQMUDNSm8np6LUz3lfTs07qlF7c3MY0x7ytaR1CD9R99PKBJDCH2Tw2Ny0X9
qze+uMD93ED7QXPLp+WIyAHZY96iI7vu2Rc3OGgqxEUKtgVBmfs+qD5Hurny270EqejAmKKi4rC4
rgOGuHjB0nZdB8lY3F1ELtu6ZUTijyaCtFGI+UXzuG5HFne3Rf2lSmc4b50J5yAIcQLtu5U9ErH4
uCKgjhW4umSP8DMrkpiLh96q515CpZoqzJIUS1b08+xPRi/RmO3W3folaM/rimzWxEC2HmINaw+Y
6xVRu/K5Fxczo9MNCEuSPhrhPSL7N03qruvSLyF7mQWPrYef4COoH2wCuMa4Iurf1u334lqSx1jF
fCmBPa/8knk1jjYC0NS0Xbf84mIi5W7LoaDlgCHBQxw46EuIdcmjMH5N2GM4/xjPkhEgwY2+foMC
nLTWgRWkWNxMSwQONEC+2I05INjo2B+5g9/nuk1Z3M1aC9vOVHp9IVo8Qm68Kap03VlZgoq6uRVF
KFl6VLFfBSTrTfi46qmXkKLMVb1DB7fCKjB4xTv30ejNlUsvUl4N26uhxYjAx5b8Gp2J18LF7XPd
Yy8u5thkaW923Hq7V+/EgOsaFe11Sy++mA2W6Zhbc+fbMT6iF3bO3eqwbunFtSzjxpUjoky+gz6E
zGCSD+XTuqUXV3KcER9IsFHz9aR9H5W8xfh45bcSVsQvDZEW2lXszTy2BRsROeZbUOUr3+PiRmot
gg2uy43EZ+FBVtGj52mndTuyuI9uNZnGbBJgzU5/iSwd8YF199FZYk5Kr9fNuc8rX9b6C6zOFjdH
VAjXPDcMo8Vuj8aQpJcPGuyVw4Rg0qYdsIhft/jiTsKvrnO4atQsuB0hpiS8T5ocmlXJpuMtbqXA
QFPCLOVWIpgwDt5dxER03YMvbmVuovKHV3oFLT383Lv6U6Flq/DKMMp+3fDeHnsT3Tk23G7iTVIg
SoDizv/l7Mx29NS1LfxESDQ24Fv4O/6qSipNpbuxVlYSGzCdwRh4+jNqX+145yiSLyJFkeKiwNPT
nh7zG9Ir5kFT+H10MgLPv8oY+5OAqdL0hqEDN/Wa4wBT/T449g8RWi/peE9N/yFfGPgn21e/F+5E
psTSJOsZx367gindABQHR2PuOQ2d2MxM3OTCYhqOByBghLVoduyWs9eTuyKiLECbZ/9avw0A35zb
GEb0kd/HdDVEDfqY9kCjIEdnC4hgswr0YkIF5ffgTnBavlj4ye7TnbcgCdONPU/T7FdqSV0lUT8b
Cq8aLIfGJOg8gVsoQLZ+opzUFROldTweocH33ObtIkjzosXsldjS3I3Otu0BscMuIiUSBuhZ+iES
q5dqA92qv4ePiID1pAYnnsaC46Fsd5xJCBav3+d0grOGDzKI7fN4rxE3QAT9S23klzdTV05kQ96o
Q0IXhgyHhuCxlQL2fIKPfyvlvL7e/z3Yoy/291fDtphwOBSOd86na7avH5uo8bqpgFvO70PbTi6v
lmuITzjEFos04hRsU+IXRK7IRyqaHRzp4i4n+kjDpMoAR/X6oK7IB8oHONwqtLttA7xHplH+qNdO
+q1arsaHb2ROl2zDnkKr8xysz7tgfquWq/GB/+REFgKNz6pjYC9DtZRA+HlVO9LMic8jW5cA1onY
eKrmMT/0GyUbr7NgmjnhiYI2bJwn9lqjge2xGuaHIfbsjkxfu4D/+5ZPpLuBuhyLrVlMc8rU9HxQ
5ieRg/3T74Pr8KBqDxt0N2QJinrD+zgM/vGbhE5gJrsJkinFOk4ISjRg78EwF9fGflPcleAo1sMk
AChEeNyQi26XFxBjX7we3JXg4MidJHEajPephqXlCFqdnT75De0kTg0bqR4yVpi9gMfQR0PZrrlf
WLoanCbH9eQBCvZddVA75jYEzMUCteX34PT3eQLmGbOhsuPdxAFMK5afS5B99hvaictNd+nQBVhP
mgVmFT0Y+s3m+U6cuFTLhFbKRaAuuwCAvUnYzYDw4zlNnLiMwqHdlhjzG9aOcGs2j0QQv3SfulEJ
wye+g2Z+f/X/YWP3fj243/EkdaISzNsphloNG6AMFNZEdvQMG+DWb3RXhxPxGfzWGGXfJD+iS5dN
b3a9UL/s4Cpx0IIek27FRl/E7xjQ3WRWniM7YZkRw4AoxfrdAu9/A93SFulA45PXBHe1OExEO5BT
mCgshZn7ejyAOH31G9oJS67s1OgME+WgzQW4xHesZX5HZFeHc/R7CokzZBrAdP/athYMer9SXkqd
sASlJQexDAts1ozjZTnm49rqbvU7alInLgWNR8DpcasBivdjNMKuSomPfq/bicuaSSgEJ4g04HZY
pKS+7qlfV11Knbjk4dpkYkbkaAmkIEPVTSq/VOkKbpCD+/jYMElEmt5QXX/god8S6Ar40Q8genjN
jHcQLeGFHI0nkFuF52M7QcmA0lzGHuF+yLAcEvUI5v1f9muvQ/zhzODqhFAlVOjxwvXvMbGUfOug
LP1W0xj8Q7gl0OMG98XweQ9Jov/yu+R//oHupexsjz5DiaK9D/glZAlSmXjchGYPh40nyFpWNbxH
jwUHoCwF7NtrtrrEgnjq4mivNfYxw9J8IekBct3RTo1fnBF37Uk2nvMaHz9n5HkS8dMQDX5P7oqh
JAPvn3A2wg0QnslQMH5TdJz9lmPirD6cqCU+gOS7ZymH7bp6k2S71/VHSpylB+nP8GHGc8+zhuE5
XM1Y0vvJRADj+30Lli21UVTjfS+m/tWvycsC35m/bO9ev9mfAsJZfYSUzFpJhjuMnuCHkur3ALGm
n0GX9EtUrh4KzSwdrDizEdt1mOnBKfSfZm3+VjH6f8I5eY26/9JwozZS73uEsn+XASt5gFf3c6yH
GLYT8NSG21E7Bc98GDxXvcRZmGqudTOsUEglzfw52uOnzCx+FV6XyASXuFEwAFzvBxvRUQSoXNHX
q19bUZo4ETvUGh4RmJX33qbJLxmGBnImC4Mxr/UmcTbyUaJxnYOaPWzVzf4S8q35muhO+oVt4oRt
oqZUZ1GPV2NT2KFFQQOPqcY++z27E7lbMG4Kzmqv13Rzj8s0BthqPNu/5JvXN/CH8Eqc0D1adKIt
BKcnuW7o6aLPADf7LTmuSIqhmGHTCFVH3Gw3PeC50wpjBnn8JcP/h0Hzh0d3lVI9TUTT12y4W7NE
8AqX7f4GNGpdgxG4rmD/Z2b4iPry9F7LKHzpm2ULsDXqsh856doHCQAjrMvahT2AJBi85MmrMQ3F
vuFdvbTDV/BAtQa3Otx+LKDvjRck+pk/RtiOP6zBhLFWWCe8ysthYu/1qV31VT/NIwFztUdFcnrQ
0/jUDMyvxOSCfIBzXolVK6uwL/wp2QjXtOBfv6d2gkuxodesxdAkfoJOXR9+qdZF7ABZtay1xrhi
U2UOXuyi6r9sev6fWe8ql1Ye1emMA2EVNjJ/95qtYIBru29+L8SJKQCRdyZAjK70BGfFXcAr+Yff
yE4yjESr1Qo3v4qEHTy6HnJYhXiN7AqXeGNHlvIBBmjzOQhVmRm/9uvU1S3FMg3jbcbINBnP+5zD
0WLymyGubsnC/wDGQBgaxk6XZD4A8h/90p2LGoMXJbwiKCYf2Mmw1xW4PYZbuT37vW0n3cEMsRZx
PLGqFbDZA2L3ee1zzxK7yxpruDlgH4HBSQBDEnpJWe85SZxEJ6RK5g19Y1XWJycKHw/bfPR7IU6S
o4eG71TUv7ruNiVQF2ABf/Ub2QnGpgHIfoXxTpURqspjmZsy6rmn0OA/iNX/2t+RhQcq65oM2uJw
hou5hB213JRfcnY1S9CIcxGwV7g/pfVDRim41sdU/yWB/j+LoCtb2mgWpApeXKC7J+1TPCj+cZo2
zynuAnPYFMRk3lJa5bDqXGl0mZrYL3pcXk6jld2OdaVVFK4nkMtrffgdHF1cDsz2cjvDSrhawA8e
+A9YG/mFTvj6Ef57onATJsDOYOSFjSdBovdNNOZ+RcLQiUtQvlSrOaFVY9e3/NieZut5dezqlvbk
gCmPoLQKJ9B/l4l3hR1Sz21/6ASn6NOa0MPCr4AmH/aleQat+b1X3Lu4nChHZ0jYYmjsTSodibsm
Xvta6iqX7NqMOdQRFIs3LFOi2ZgbV3Ae83lu6kqXdJw1EQQutMK6Ii9ZEC4nmJVKL6UvfUX6/vc0
hOFGMsOHhlYrrA0BFLzTxU/QhXu+34e2FlpF2htajZadeMDgSOi1UFHmZEtBpiY66p3ClQvEfbh5
hWcWET99MnWlS2MWMHiDYvQcwPCzGmCMHmKX5fk5ndAMUDydY4tpiHalx8E0n4eDeGUH6gqXFiKJ
nDtE/Qwjwn9wvIIRjp1hc++1qgAO/fsH3eVI0Sd+bBV8L25yjstFdV4bN+oKDA4etETzbatS+AoU
dmcf0VLotYZTV2HQHxpOqpHZqo2O8jy2YrosPBu8qkXUxUK1i50AEY3wPcdRXhOcFG96iTwnurO9
P2Se1qEMaFWDZdXwfilJD+Ntr4XFlXTlaoX2IsbgA9j+RQSVWwmvkNRzdKfQxSYYm0RRTuGb3YDe
QiYeQJdSi8avS4a6fCg0oWa4F9QE1jbjaT1eTTCY12mQurIuNcCSLhxUWM2wEI0iXiU29pvorqhr
h+Dcot8krOoV3adbU8qYee2CqCvqGsHEU/0sYC8VTB/GWH2cusBLXURdTVcHH9Z2lOtRxV38CdQP
IOda6zlR4t9XlTRZxyU78h2m2oBOHzX7DCfcd35T3NlOtJ1ej6mTR8XRJxqjAFSvH+e282MLUFfP
1cMJJk6aDKuWSZ/SvjvPLPQ6pVBXuYQ2SAY6WbNVJsxgZ67OPXzkvF6Kq1xKmY1mJE5b9SOKYrh5
bAu9ky9+gzvb2iHFdVFYM1uhDxoqIPo0GL+Oeeoql3g8LvKYA1OhqH3KZlm1GfFbxF3dkhmVmetV
rlUNe0NC4iKgXsVa6oqWBrDmtgwWwRXcus9Nzi8r/+n3pp3cACO5UQ5wrcUMsfBwoxm9wWXFr6sH
hg+/R6Uakm5LZGiqNZpgAwxIwTmxfgAB6qqW0NifxHUDBz5lKeyeoyfh2epEXXRQ2hBYmAxihQ+f
eQP32xOUaH6LoKtaWpNJEAob9WrqZgXP0bYKVP7L62O64KDJbhPcU1NTSZpVVgcnoVO/NdClBsEJ
NAdQGjNwIwAdqH7vLzKEH67fgzvbWbo10aLDyEB4lqzngDFaCFj2nPxGd3JDNzUgA8Mbqar74P3R
2Evdpt/9hnZSQwbYwUbDxlRR0FY8hmXqoT75De1E5k7Q7lTTxVQgTD3zmH2C/65fjndFSyB4wqQQ
XfjV2Kqrsvst82SdUFeyBKfrfbMBnlrFoSj6LH4QKvvX641Q55QZqYajAWw0VZx+EaE9R33t+ULS
39epflEL9m8MI6MT/oBl8UT/Rvd5HeJ/r5Mopb8PHfeKwIrDmiobxp2dM5js1ueV6/irwKVwCmtn
0vjVmairYNoWG4YDM1jMk/ohBi1zGQO//ZWrYGoMYRKwg6VicETjaCUIdew5tBOe/EhGeLuTpdob
y1/mcKwfeZf5gVqoiwxK0ylDEgqWKulkWAAZnD0k27D7pXxXxJTJtTENrbHi9q/cBHZqRe234roi
piQkuU2A765g6HlN2PwIYOPFK5BcFdOAe0pA2IO5OmZWZJrfxjbzO/S4gMOjxSVYYuVSpd/y9ZwM
nsM6AZqlW8NGVS9VtAYlzZpqM/zF72U4AcqyBqsfyhuVCTJAWpob0D5/U5n8uRZOXVkPzPbWUCq8
jTpb+INFFN2CtJn9sqar6+m2dIQhYjZXuqEvyZ53BRz0jF9UusoeeFlNIZTySyUC6LOMrl9GqRe/
86ur7IHOIGEgbs1VDqPyJstuzUb9SpEu4kjKrKlX0S3VEakPcJ07UbV5FgtcTU+wJXB4gHVT1a3x
r6iJvg0m8qwXupIeeLzqvFHLXMXDT7q1p5bVftsfV71DlZlivuBl8+EoIWe4AGnilzdd9Y7d93jU
rxNadLO9pabVZ5ov818W19e8/ofU6ap3WNBHcLucZ6TOJrlbKJb/mcYOxuxHW0/kvASziIpkAvXY
b867okU7b7aBJbiuuiDQJz3o8JQqP6o3dcVC4Q6nAZg5z5UU4VGMuZlKGE956TCoqxXqlokE+arm
qg+OEU7xzXjK+q73O7MkToZug2XrUo25CROl8FHBJ7TE6dkPGExdrZBEk7mEElVXLIIrn+y6L3RR
flgy6qqFaB8D0h7DB3Ng2Zu+eVeL9INX3nB1QmKbFoJmH10lMAm1LPnRysGv/OEKduB1vOm+wdB6
QP8TVuICvup+/YnUFcnCpX6oj5HoKorAv1Hh4zIPfgnJVQMleZLb1Qy6yvf8FGa86Du/G3EaOxUh
y0KgkuA5W9UDvxzjzzjkfmuYqwcKtxwY7BAsyShOTgAGwO/X85zl6oHSo45lAARTpdu+MGwr8rH3
2xC5JKO9G1q0Jx1T1Q1CfMntBq/vUMTf/ea2c/Zkg8w5/LCmSoDBQmFR322eWyJXEZQvu+xNi6Ft
LmF7vZumzMZx85uBrioInvEBOLAYfYqaazuYG2TUfhdArioI6D4hmFAdcl28nGCSBJdsGFX7fU9X
GDS+9pslRy+qCGogbOXe5aPnhZ6LM6ptR2sebg2kKhGUtbxX9lM3H50fipi6wiAsJxy20Bh/XWx0
mo72mwmUZwXRdUsjMk+AwA/obZ3Zfdnh7gxgoNckd3lGsu4OvZI6uw2BOdl4g6uBAtPIb3CnMLSD
QWKCkaQ3MifFAeVRGvnFpqsNCpeawL69Xm9TvZJLLsVxXfZ89dssutogiCN1JqhYb22QPgZSntk6
+hWxXWHQkM8RXVDEvsHp0RahZk8xrz0vCl1dkLJ2jiHtXG+13j9quJAUY8A89/2uMogFHaoS8+tL
MQLOcVleAert++TO+TNp9EjsxsyNCQBZ89imJZ7fr4jg6oM6LtdAbRkG5/wD0DWfufXbE7riIN2N
/bz3yXoL1FhGjTxla+YXmK44KJLTHkgbG5wK5WmNc+iD/vGKSlcYZHTUrSTd11tIm68q6C621Z7v
w0mZSJK7loNdb3TaHsa1vrDDj/4HE+zfS4gjrvFiKaf1tjYdvzARRMVKhtjrwAzy/++jw1YkanDF
sd70lp2msHnhx/Ti87qJKwtauxZ1lcmst2WJnmIhAO+NI7/rdeIKg7A9XlVvVkxAOr1hLBtQbdZe
SxVxpUFZH9bDJNv1ZuejxA+6JtnqNU+IqwuaddjSusXHPLowKLJ4OAf08CulEpdoFKwNH6dQrbdh
xjXH3h7pGSD5H35f0zkFwt1hpQb9yLdhm65HlxZ4SV5Zh7jylzBfBtTJMXRG21LNdTkKP+cSwpy4
5Drap6zF0Nt2XNj6Ctlgfp/Slb5oM4UAiyNyYOS6FEPfvOShbrw2EMTlGU1oi6J669db34QlTcy5
T/32VMTVvDQ0FGuEPzdm+S9cXpVySn96zRFX81IT1hz9gsBJDnIZwmEtclTbPV+Jkyn7bp9108j1
1g3Nh7j9PgSZlyyfuKKXqR9YPA942Um4ISfQq5gWr409cUUvIXCwQ2PxsusZwBslr+jr8TrsENcU
bSCAgEW4SoYNe1+kcNRIwdfw+47O9lVHiJS2a9abqI9Tm1XLOHgld+KqXVS8DvEaBOa2STiKG1nA
qNjrWoO4ysJw0vsU9lj9xKtjbZ2j2/nwtC4hrraQiSZtI4HnZkx/Vwf9sKq98XvbrrYwU2EAnTzG
lsmjifIyPA7PkZ17ExXJIw1xULiZcS92/nPMP3tNEFf+swiZ0mXDBIGe5gQld2HV5JcMXGxROKZS
z31ubtNGU8BAIMhb2jnwHD35fbsj8zYV5nW7PUeROUGc8pmsavN83U6KfD1gZ1bj0edkv47bfrWD
H4GOuBKgKIvjLYPv2Q03vFMxvKJjmPAMysxJknOdcRQ3EnPTpGWl6Y7p3cbs/Jfd1H8qAf9byCeu
DIgtB45LQzjfQhRNw1u4Sx28kSMzvKTRqvgH1URNjltIbeUVzAYNvxtqV33VbBuaqwq7mhThzrb2
jTy2ydYwxFTEr7RIXPYMVchXq1XzbYw4UHNR9At2ZN+9wsSFz6xtQHkH88HbMXZfCRUNKsV+7lLE
VXGsQ0JkFrfzLZ/rW63yuogmP1kYcWUcx9FNbQ4d+G1bx7iYpnUvALPM/cLEFXIMoai3I6pf33jb
FlmWvDbIHn70D+LSZ8w6DfMy4Z0bxGIhIj6US05/eX1QV85hGr4CUI1H51R+CRdbJTr4y3UX+eN1
F3HVG2tcH3IlHM8dixPZkhvL/Dq+iKveWLqls+mMqRJHAynh6ROVB0wOvV6Jq8PjK02xAdnmW6SS
B9psJ5Dh/DYLrg4vX8NcN2zG0MzGhaVB1QLV4JcJXCVe3Qm61oGdb21ozluDHwBQsx9mjrhSvFQk
RnZczzfR992Jrnt3tkwnfvtVV43HeRZ20My9HiKzCUePjliBnvKF+51sUidJNk0n2yjs8fT4slXd
TPKRLTb1PNukTpo0zAp47SKIpvUFHLSn1jR+xQwXhRTaUdEaU+TGl+HrsIlnfIO/LOWvp4w/JDFX
SLTaNBZ5rlCVYqR/AF2ovxuW7CH6Sufsm1couXKiCI1w4RJSLOl9lhe2n//l6+hXkib/Iyiq4feq
xhjznTbXeP669blfJLl6ImT3AA2kGDlkuyibJCxDOJv4JQtXUSSWMRr7A4PLbHrik8LVy+R1a05c
KlK6tcNA0TV9S8kYnLq0fRsI7ll4cGlBHWA5OrTJfFOvGgL0fX/r6tZzF+sKi5bEHroeyXzbm/qJ
6K7Ui/ILIVdVxCewZbIkwhwUdY1CqeQlUG5+3oMQwTvbb50MxxDhreTjcutlcsKZ3uuCjriionQI
mi6AqOjGanXlaV/mXeqlVyKuqCgctjrdgW2DMViAPoq1kLXf3QJxNUV0m3MFOAemyRYVUGzkqVet
m7iCojjVU6sDDLzC+ekpEKwu5ib1wxsRV1TUMJOHSWzmW8Y7K07LOPWiGOWIvjuvpdCVFsWge+bg
Er5+zbEcqXlJEr8eXvI/uiI6Tns9YcOiti4+xXK7WcOk33LlynwmnY2wXsaWpVPkahdWSBb6TXBX
5BNECi1OCkMnKrujhHKSo59FJXEVPhxwkWNNVkzwgMmnlnd45wpXo37f0qkmvcq2gfcM+xtJRHSX
gZGXLl9yv+B0JT5HR5iOpgmj17IOi0HNQ1dunZj8+BTEVfrQYO8bqsb+xvtOFRPOE+Mu/DK+K/Xp
llhPvJ3mm9FHAe3WQ1vLF6+37qrZZDOzeYq66QbzS3Oxkh5lEMIwwG90p7K0oz64aMW2W81QAKfD
c9osfmnZlREdSUB1Ox7bbd2C+gQylT5vQ+i57XeVRND6zjLV+3YbVP5JoOxb9HTzy52uloi38DOI
4mm/wchvBgRqja8za/0ILMSVE+mYaNy48u3WZfvSFdB0JF3Jpt3+9PukTpjKfgCWccMnDfDIxjbn
dPqbRuTPUk4SOwWmoY1Mva34pLh4XX8xfF5yFr3V/w4TUSBrASjefAqOrJv9To6uzOjYwnHPWLjd
0uV9MAcAPXl+BVdidPSdIJBybjcKa4zFqGKhfrYExJUYBTsBnTzHW5J2fttk0TXy9MUhrr4o24+g
W+pou+GIAeDhcKii1p5FEVdhJAgH/X3W242Tun1B7Sgwxa7j5G8Vhij8z7XXH05frsio6SY09rds
vPXo8yUfYU0s72u6BvRRLujLfw+0WTR+nEVbw4t3P9p5+GdLbbIDPcpHtXZFjVuvfipQSRyOO9xq
gNTZDiH1h6hL6fQQaWXqu16nfXkz76Jm5zZEu2+1AOWlT72Kqan2JbX5E4FLWXTueQJbh5UKUB4K
Tpn4QgIa56U6sAScFJ8GfZppatYiYYGyt6VGMeqZxCagl3YJibimG3RTz3bMSXnQfdvOuKm8r11M
PmETZb6TcFie6KfxXX+W71FukrPILzPUzv8a/LS9pDALSW9g4IFulORh/ivAfSSQODjlCPT315m4
JPtAhg9RE6+/jg04NaBWuymBLQrsI6phS2j3I+oP3HrRQHXDTTZZc3xqRqm2y5KnwX7J0HaqK7Qw
qfwhmNk6PdGO9sk3YNF3c0tgtVCXebo0L7PYqSg5hSSxNNEwqqoTVug3HQib+8cUjqP1qR3Q4Fe2
gvVpCWcCyi9LdPD5/upGLk9h3+7kLW6Ya1swHgfs+46Xriswag0sMRVLms91s/GwCiy6+E9bKpfu
kqddLEqW4H7gnGZb8NbSQ5IzUAR7XhJiePp2r+v+vY2bZjgLaXrybgBdAU+z9P0rjmzIw3ISs8qL
bWn69hKCeJO8bWWsVTmBK4/7qWMF0VT2HdpvstZC8G+JEUHJ+mxYTscGFXoZ2iUCaX3iKZBNERmG
a84gsCsmwo5PdoZcq2iSfAxKG7aCFMdusvYC4HTIzt1sRFPmmzafjVIRGJgytOaa0DTIfh4gWCW3
hI+RuCYRrM8LMybw+wmAbzIlnwJ7z0KeAd4NyYwoj2mM/8GPmQHYzdR6x0F/TAuwEsf5i2nyuS1Q
1s3YraZzuAJEFKOSvhFEUbH0SWqeDSM7l8Uci/Uomm5I9hPdeNBfTJvvdTkLcIRhfnMcvBz6AX3T
Nsny+azHGLJZokJel3EuW3FRfCbbKYKY/h/biG0tgnAY4MvRN4af8rBl68fJkOwzCgdcnkZLmS46
brm9zvhndTN5shxFrSaSv8XVQToXwCLb4cq7HH+f5JZRWQTppOBb3wLws520MXL/Eu1MQscH9n0z
/MxqptkprDuTPCpgI3/GR72F1yAPtn81LFS+7aKNP0Z536aoWdSBfs9Fe4QAzKT2eKDSglFcNkSP
0XnhcUqebbfT8GJEp/pqNzwertJm7VTM1Kxvp9Wo/oLYSkw5UD3+sDVB5Y8DoW1u8A8Kmmuwr+Iz
S9HCPZqQTMA96i57sXQI7u2KfylqUF2yz8uYd2o8gyuphvZs55Wod3XKVf8Lt3lRegZWJs4NtMQ8
Se/bkoCqXPSroLIvW1wLjUmRhkm9l/hld/1mTEOyXqeAxPnjaMfXORBkAsuSGAU+F86F/APa2Oro
Q2uCuodp6cyjqRgngSpa2nTjSx+FYf0jn5JO/JjhQjGdQs2xxa5rlXYPNfDdW9Wn0aHeHrpJP6mt
DZKyDVdLL3qQZn6D1TTYSlKbIb3g5jSLC+AX2+4F7SMJexFDxO/5iHt9tETzWdzHdEt/KRN3UO+S
rLdPfd9juxB36/w5pczAdU2a5tei1uV5kBvPim5ERAXlfMRt96ExR8BP0YE9RgFCm01ONfZL0zUc
MSfCIJX5m41xEV7bwEzi3GCrFpRTnonknKHLTJzmvA6GQmYzDc5NENh/0j7vp2poj1NyYO0oLO47
X1/v+5ityDU5NpCSk0LyHShe/fYQ83ms53dtoNlxxpKQ4QlFy7E69zkn4WVRPIyqAMKMITol6HD5
NO0U9bIondk/OkqyhzwZ7FOqg2a4s6zukiuFx0V8IQiC5QkJ8N7tYzkBBWm2+onZtEZXSUOOpzzt
p0eUtZDdE+hG4nLPet5chjazstgJKsYFApR9A7Fzf8MkUVkJDPLXuJnYD8om8T0ew7F/N2b1gZlQ
RzIq07DOT9sUtUiIgGUCvbZzMAtjuGC1qv5O1vyyktbc+z6cziigyxM4Nv15WPi13rYbCZvhRCWu
juYsueokCgsW7W95t+ki4UdXMMDhCgnEE+Zl8w7bCFModOKWZgtscYBJ0LLsOPEsNQUfsuGxieOn
LWpPNNNfuA3WSxw29cnAEOkEl/LHI9M7SnltHpwWuLqdeLeyUg7ByooIHL3rJsC/wuqssieWq49m
1wbr+fY943y5gFdOTuna2o/ZKobT1ABvDbKAnkq2bLHBtM0Flh+6bXcQ7eICJkwfW4ITRIAVHqmt
f9nzAOuhmFhB8HFLaCiigkT7U7Tza9RsT2zV4RnY+w3+qZ0sl6yty30O36jUfMVrTM8TyI03FLK+
S8KPc5LYE2St/NTtzS/4kdTnwOBGOYfRGTYAm7rITV73jk+lYOFShqNBWjHRc9jlb82e3ZMRWsGa
QuIDWFJfZMJcOzKxx5GoJyE3e0rT/Z3q9dhe6i34SjYkhFa0D8t6PEWCDwWP5pfBtvl9TnN9Fjb9
1dbrG97iurjs8Q6pGhZEwrCVU5g/4sh5vGYAIMy3dcAS1AcLLLBirrHbSmgyX2SStkW+ybWMlQxK
Mk7vRcazW7xw8MOH8B3qWAnoSqpMZDwWrdFFM4b4P1mPLoQVzUNnRUlboViRiiKy6DFpUXQudK/o
M/zqM2QaccIvxPvTAU9PWYzZMT/HPEp/2VQs4sTWOv5YD4nZT9OqcOkYxU3bPEY0oqgdrCba38Bt
KDvZsOfyynMl2xK/XxSXNOhEdMlQmdru4ZBET2kYyKEgHL2oxaaH/N9hp/1pbJIgr3Il0s9j19Gt
SPZl+wKfyDS8MD2Jz1YpO2PPh77QO4tJvmFmajCM+VgfL4zgJvScAwxadnsff4Y9zKAL3dT6czZO
/JfmuPl56DqDt2NaxBTCacpgOF03BxIICmVv0mBT+3vdM97fMx7m8UXHPITiugsWch4j3ZFTrnoO
tVNvxZuZitlcVULab92xtK+KdUl6CJElplU8zrvF/dLOzIkvCs9K0C6j3iWsjv6dM5jLvcghVKaI
RxRbUSO105dQdZPBpiqv1a0WY/9pWHYyfh2WzP5aUqiWCp0mUPJr7Ihxd2X7iJwA0I7z51V2w3CO
jQKnru131d4yODR9CCMi2vM4SEzIyeRo5+T1AgtVaTL9drGWH9ia6KWFD9Vm+uf/o+7LmhvH0Wz/
Ske9swYECBKcmO4HLpIo2bK8ZNpZLww7Fy4gCYI7+OvvkbvmTqbaLs/tt1tRUVUup0QJJD58y1la
3aZlWI8NsxFYSjIE6LDyfuP3zWoHnUyNDkF6tm80ZPHlvYbcRH/T9YToTUvGPt+Udobc0GdgHYfz
QsEGxrdohs3UsjJyFCE7JM3UNxFKwSvIvPXAP9v2HrIevXeAmjlFPsbXtYsrxJlHQtm6fOMmA9xT
Tdoatl0LDesIvOAyvZVwJ2WJZsLJsBSly4JpsvM8JB6tEVfcdAlm3M9qx6FJDa3iRYJ8x9OybG+t
ZmnKG9t2myLiSHntYFBQQDqhboFLuNOvjoiRW5+gtViA1UQEjtJ1MmaNRi93D+Xi8Hwv7HQAvsb1
xhwwwF5kwVSu+n4ZRffsaIjibSvg6K3QLWGbHjoyn38oS+Q0yMEN/tQYCzKcjXardAe9e2Ql7gIS
RTQNyN0DS4nuMJTKiiUO8mdnZPyh15bcw3gOBUXZLHuEQjs/cjY4UyDltDh7P09LByXABPlsZ11/
yIn3n1HVCS+o2i5jYUfJjmZpHltyrodosoR2tsyxliVUk2Mvt4NdDiZkqpoixDrxtI4yg6o2XIkb
7LG2ebKIJ5a4rpALXGlE3vVGIl0NRpgubjK3UeSFDD1bQxQ7ZbMdLCNVvPp2egfgoF/Eq2VN9t5b
MGE7pO1oHuA8mf8AzmNKw16rpthqpFsl5kmztqPVqa6GqZ7pTSXPiVEzZnDcgVai+ubT0nFPXuqs
cWua3gsx/dstkPRcgh6emyrILOead6uPChHGMQ2sTDLTo9HmMCcaXSclYV5IiXzMY/xWF611J7sp
x0k0SO9WzF4+3qy8b7vTbJv6pZmbhYJXrHIrMDnF8dT3rIPibrvSI2/y6VT0soX/+1w85aVZ9FNm
u2oKWQaaGfOFZUXYAFAKSKv+HOGN7nxEezF04bLOXbGd5Ur3kxiKEkJtq7OEvUItTKDdVD0hqavc
oHFoCTN1fJD71ffL7zzP51u0y9mnwuOzivN1yJMeBrhIkgbXVNiQrkX2BZA/UbnYU5x5Q77LMakL
8mWl5YY045Id5NQv6bHoSPpJT/wGXtlOoCjIuzQf8tiDBz0L5wIQvthlSyEPfctmiIRVbICkXGrA
cklbP4+HxUnL41iy1drCFoVcUdHNj9nMrOvG8pwhYm6l0EIAJcnbrR3qitjWjHXXWU/zl6VschkQ
ZLJz3HF7FAfXrr2d8WUFNBWdNDAXtpu3ccu19dlI2wnQRPDCRvBqO7Jan2E2X9uJHJ2xheeFJdwV
OUXlWVHj2Szdppnuy2BKV//Wn6v1WXGV7u05nY4yRyUY+Ettl9cCZ7h5gfusmeLV4AzcDs3U7hZ7
zf5om9GoWM9eg9MmX9pp02Q2aW/Qk0NRPlGkh3AfTb+hhq7uZT8AaVus7k6LabrvECwTaljmHsgy
FPKENn79PRW1r8M2N0NE9VLvGc+Q38iuOw5+Cl1HiAEjjLW+w540cFtOQCEQuMZ6WdVxaMshjTM+
ezc2XFWHXZYOKEtrQ/hX7Oxzs4Z4xrrr9FKNKGj99qqplnbH6eg89cBj1siv/GmOa1t1eKpwKJaB
7As/cSGj6gSm9JQVLr6e6CGVPPUj7TXnI6Eq7u1CHeXksEjKdV+uRgclb8kd7BjXq5Ys03hNmVge
VpwVOq7SGRTzDkIIsbaV5ybtuCx036Sj95D3sC3Doue1DOGsY/+BVXPYvmCyWQmg/Zo2PaJOb5Yo
m/V0ch0PcbSwrf42z0UGx+G89g+qmr8D9Omuzz347d8bOkHNF2NIGcjcmHCxIAS7nVNjSGAI2IeN
NxzIusTcqewirut8uc5ouVuy+mTq3pnRnKBegsMfkDOI4ZGGhxb4UN9MKuzdZNb+vrDpKEMwjmC4
YVd2rxOnFtCVF72z3llrM9rBWDn0Gdh5+WWiI3N2pMaZFE6ML3pTGhChZAV/hNTQ+bofpw7pl1TW
duTod4RzN6/5nkBbejyYHkPZ0Okoba8sSQQWf87Jg8zI1B99DtrIhoKWou8Bk1Z9WM+mHh+GQhU/
MGQYVIQjeEIbRmUt3mUFewdqhyMvr6wF60/Z4p64qlW1UXqF368zdobvOBCkNEh9qJYHc2E7N6Wg
iocTAvs1Uen8nBdV7W092QKAhihUQmUb2oR2VGaFajfQLeq/OPmCKS9M7xBtBuhsyFA5Nk4++Lth
L7djTt1d6zWTTAqDPZ6Ai9Lee9K3+aHtigoPtaOKaGqcpgxqHGh5gFS+9feGjVQFmPOMSHBJPeaP
4uxGG+HMgAUKN7Af2ziydvqo62q/2nis6YujylSKqodObhuPQz69DJDjIqE9UcwZp1yMIrR1Ie4h
hlamobZcXlwRho7GA4oA3yRsZMZ+oBl8i795OVD6x1nIYdxzgHHoVk9Z1Z1EXbfs+5o1Mt9C4C/9
MQ2wsD3YqNZX7FzZ8Ru7QIMgyruisE4ZXSEREtg5BhHY6b3ocIjaoPdGo6lRTi857BU+w8zIgxLM
QPmRobtJ68BC1HFOlDdkT5rSm6LZ0zULRoLFOJQgx7BtSX0tN06NFfw817Kn8ZItxokmD94coZyH
unkaB4PohhGXXm5s9AOfMQnRJkiFJFkI8fQhjSB4Ot3XDE5XkUobF4idGeV0gEMkf3THEvZXY2qh
czAOY4tk1+3t9ihh+0ajdPa84n5piNWGoFeSOWy7dRlO3ljquG5GlI0oQWq5SUVh+z/QReJz3HgV
15haIdEOevSj2jugW6cWipF4QVIJ4lIZZGrMp03qoY/5pO0sd+wA7QuQO7DJmHWjlYVAW/e5gIaO
1fiFCTyn7qcriSQrXwJ3ojR9zpjv54FPHNkFA3yjnnOJ/0aGVPI5qOsV3wOy+t0zmt4urOoxCx3C
rOxwg+rGW7vdjAtUkVoISHslcmn3mSj4wOyqlvf8zp/rOY3dDM94QI2nTqQig/wqOguiT21VZmVU
GpJ7QBRQUD76qHaaxfmj56vlf2WTatF4mPRYxkD+Wiifajk4oad64gcLUnHz76HgLrnBA8tlWaSq
3fXw09w1fidu0Ctz/t1pzAVUpbNbW5G6a3diIEtUNVIFa5P/6YzxH1+X/8y+q9M/Zxf9P/4LP3+F
wldXZPlw8eM/HlSNv//r/Jr/+2d+fcU/tt/V8bn+3l/+oV9eg/f987rR8/D8yw9xMxSDuR2/d+bu
ez9Ww+v74xOe/+T/9pd/+/76Lg+m/f73376qsRnO74aI2Pz256+Sb3//DY1oG6PD//j5Cn/++vwV
/v7bfds9D5X5W9JXz823/o3Xfn/uh7//htLld8fD8IKgrWd7/hk3Pn//52/s3xFHKRqZNih09hnr
06huyM8v+t1xKcGLiC3QTjojdHuFiPj339zfGUzI8T7MIb6DA5z99t+f8Zf79D/37W/NWJ9U0Qw9
3vg8s3xrFHUxJu1yaBQaZ/QA/d33vPmK3nBU0xR9UntrdQpNDXTt5psx8z+A151H6m9d8GJ4WoOY
VNGeLslKGJoW/paORKMHV3wuTPsBuvF107xxkUviN8nsOa9QXyRyvJtXJ3KaIZrBv4DQQTwtLyla
KeicHDq2IqHowmFAiZl+BGV/5dy/dfULEmrl1jDuc6QF55x5q2qJCZoVKkAi7L6GAsqJOPDqgWvC
IPPQWuqr5iNZ7/MT+tbiXhLHMZ1DXa0h/2UJZyvUduiKhEMmIcvMYSTTadbewZNu1Fk6hMHXB+im
9x6iS0q5dHSmYXWiErPE/s14rG6GR5T9aJagp/3BRc6L99aiYif8rMpvIVkZ+lWlCbzzotbxI6Co
t6a7yfwlGpUf5eh2/rSPT/98z1/2BHvnUs6vlyrMTHzIjy7J7IrtavygEBgxpDTgWXGqOAtEum6v
6ukwNg/oA0Y1MB0fXPq9G3j+SD9ZYLirtWAsMg8JcuHtRE7D7G15l4FvR1DN4LzqsaLOQQtoC7kf
OUycqddvLe3F2SD8xVLEW4dEUhKcnQlAHNxak7P1sWWcBcUaOL3F/JGy8LtP6UXMmTgxQg9CJO1T
e198x0R0XkIU1Oljdw3vjPXD5/K91byINTLtSsEk04lveYFiD7XdoIHpvz4+KyIaGjCY7m/skn0i
HwY4+xXV96/rieTl15vI59Qyc9qpZNi4Xlh8tp+aa5Vf5/eFFpv81CQUdmxeINdwiqavqbvPg+rY
XAOwthyKNPialgcbVTzaD1fyyMew/1yeuPU8XVkBprCByNi1flZHdVeNMYq+WG85v7ZiP+wxozqq
27JMhmvR2o+VrsLl0Yqn4KsINEXXASXRbmD73gl9eC0WX4a76a4X13Zsh+pKDKG37ZMyNjuewGfW
JMtmiZyQpRuz7fYqHsgG3c2k2XXNJu2/5tfdsd8V9X7YdUf/zsU7AlgWLA/1nbUZb/RJe/A/vHXS
l/KRXWVbgdHdLjuoHUjAdrxiWvUNw8Ac6hnR9OI4CBhHaz8DQLPtts3WKw+gnn0A2nvnmUOD59d7
Ys815G4sQxOQqpEy+9HsFDtk1VCjmsqTp0RkpyyCFF4g8N8FMR+ErVfYyFsPwxlE9NOOttistVwI
Tcbz9iU08Gw/6jjqOfpHDsdYdW60dX8UGLmnCCvT0J7qgm5NyoPhwx3uvb0T2KW+gHQXBE86pYlw
DoQptM/BjIOu1eyX+35NV3SVAwAHHquZHFLgKmLFMzj3otLu+4ijkxT0rU3icx26TDPm7OiZ9hEt
CAkWM6NQzmADpgt9h/FVl/kyGDM67WdhF5vaKWJddBHOxDHStLqxLLQCZgvubHSwr+p5xPQNjVfe
T2XQibCsskfPFHjYzKcysxOIV+cbzmwWTqP5UjT5Dfy1wnKoAKTInNNi82vT8Ah6g3rDai8Qeo1g
lQshxvqYT4AXlHVUF/m9ysEAsXuOqq7eEYy6N6Z0RvD++bFR9MZv5nBoXzLxh/2RHeg7aQi7VF5A
a9NHBt+mSVrsSv3k+9mLsEi0FOPJAxMtX+PBbe+MuBYrpj6444jDHxxib8d0dqnMMEKXb+KySRM7
1S85syN4p0UFQwqQelGReQeFR3Ho2Ad0r3e/6sXB5XQCqHJSp4lutvhqPHUDWKO8npqBUnf5ZIK+
uIMYCsJ7tvM874Pv+U7uwS4dXla20HrJrDRxHXVqgGJrWhFUaNvnrYj8sj0462Hit426++CIfjs7
YJfyDg7D6J7xrtw3Sev7+6rvPlno455vaqmyWFrXU1eduI2T2qWHNdv7yV9f+e0MiF2KPxgLUmN9
65boSvsH7VCgQaZD71vIBMyhxc/nNOivL/Xeql6qQSgyVwJWkjRRhpzylOwFf3DQ7R6z/hPm8siM
iqAFqoXm1UepzznbeCNQXmpELGvfNQzLnUzpcLCKNUjnO4G5FNhbMQBJhwLRMDXeTYrUluOjSON9
FKTpq8rAWxe/iNJOb1x0UpHyLdNBzj7MqtqNwOFQKmBTbUAsAqbIZ6dCiJJyuEJz/FBX/k3dgaba
HZt1OazVnFQ6/dIydcVo2OcSOsdFoFkZWsOOuhvRbyTb636j1MGsCEVb2W0whsjtjTWkYQ50naE7
mIkFFJmBQA98wewEQSvHnYXpil7GsHHz88Ed5it8Be/YepjbF6c6tUgS8+00gWKcNGKXYfBy7unv
PChbL7ECxDawiq2LhM4CciI9GPnE6HGuD6nzxJ27kT74y2Pr/Bicz3Vzb09bybaTh4bZDnq8U58Q
viH2tpbomm7t5fyhMVjsli04e9a0y7Mk4wnPd/B/LdERK+ugTe0qsFp6NQmDQmQql9BrrF3JgEbr
xgco2V4xqEGO6XqEX+fBh8Yd6Gc71+g4o0vIimkjRz+Zsiif9HExmJGX7B6qndsRpihkPTrikbmf
4DC2hXf0rspwhmK7D61zKCu+yf1im4vlmw2KsifMvV/lADYxwAob+8704pMzHNFmT1jlPsDi+7ph
9dfBzw8eYDC2g+EynDRM78ZoOkVZDTAMxua2b8W26b/Oltj4yHJgoovpePO8Eh8z2SK/LYTZmtUg
5jif6qrcrroJC5APA6tvqqAU5Irk8qHUHqTBA159zwuNuaYKev1Hn/4osh1w7ZUfVWBXBh2br/NR
xCXvtkRhhl41GFzPmF5kKOoWHzOqJuJAMsyMJpnVxjVdT9CLCEU/wXJ3HoPMbLm710V1EK24tfNu
1wxLrEcW+bqI2zxcIXNg5XQHVNF9tTQ35TRFJcY4nk2S1Fdz4G3TRZ+X5gY15cMgH5k06L/bqAm8
USBVKu9kPX9tGxVmDdAAawtNPkjlt/21C8VTU5YFcCPL0RTiu0OX+7G91mjmn7tQgQI5PvRq93oy
O0qK/Zw5d3Jxrkfj3s+Z9wLYMHRxoahI6C6vqo3h/GoIpGtOWgLHpPntRGZMtCQAjW4yk3HL0a8A
E3hnpSrhDg1TT+zc/IT5SwwZ+4MY9KEcZZzTL1abYv8ut3mGKTXS7bScqsCRxTN6f5ssR0cAqB1G
nhBZA+lhpFWcbLf46Jx8L8pdMA2A6eugdgVVe20gWL7shJ6iyuriIhcRXEG2648aHW9YZm5HF9De
j6rnV17kWwHuonz20mp1vJ5NiQDMPs3S62zABq+njSrJkY0cz3MVOv0ATCZAFAooiXtAGKMMCR9x
7zWYocIToZfpqK1cYHPAihxGyPIO8VTrUKW7EuDxzEZLlp0tZstQejJwmoe++UIIsp1vxUxjP+Wb
2XZwRgIDI6ztGXg3IUVbxj4eqYGcwG02ndrmTnpjgCFK6D3U80fqIa+asG8twUVZDz46BN2nTCYM
0C/aHNJqX9GHhnzBCRNwVJ1iGSF7j+l6BskGc+p9HvrIWTG1hV7DLdzSSBNCVDlo3BaHXxH5lF0h
czvW2o1vgRT94PB9Tcrf+qCXuZTt5KvDJZSbDUtyHMKeNUQkm7dN9zQ4d8Q/dqsMPVDJJL3tqH0l
mhoQk+EKytibevbCDtDHsT0V9HrKDzMeMnqoYI4O5Gw85l1YyXAcMQOsntiAx+1l1MDfVem2h8mF
hLXNAuJ4j0loJpvITeGNgi3eT3m0nkFFGlgpKwYGGrCQMjhHDK0e6iwu/DWsWR8Q9rWqf5xLAO4C
foqRdb9IjH69wDYYPQHpIjoC04UJS/hszX/YGRz56FXLOfCb5nYATJdKEtDuVg5JlSe0vHFoFbir
RPsMTyHAl7DKuFKPSztsFBUbAZQjSN1nBGFoShBV8PZwyoX1cxVntQu025dmIEHtPTg4vc/oOATd
EeZof50qveo8vHW3zjv95wLPazImeyiSl1eitLcKo9JtRd2TGdQ2k33Qy4QP92P5OZuB+Fm+6PyW
11OYzSil3TFeMeuCUvoDYNgbUR1KQDYBo+vK1yJrP3vmnkP/Z9F5mHXdNUtlPEpIrQGYa/x0W8ru
xpfNVQn1MoS+oHYpfEJTACOnKBcmYgbtA3Q750GGjcxiPa07R8uwdDkgA/UeeMSdpDoqa5yrvIlX
reKyyOBGkkWY7gaA+wR/vU6vnlRvrdNF1wdaEDBz7VOg4KsvKZwSpXavcXgfCODZTjbsgMc66sK/
xUD8W2sVDyPZ5h65prhxAA4cWaeTydW3dpc4eMxLY92srqoAgfoEiNcjrfsEkDhMEylmjyp0fRny
5lxETxlqki9u312BqH8QltoxCgGW6nn0m9DHWbpmEg7k1laUJM7xNJrGurEqfdPObgJ4S5TrLtQw
MLXNH45Ct2/tgmlRsTss160HIkXR7iBWsIUySkzwb03ceOrcLcnHqPysz8yjc8Ws7tMSGN4Oc1sg
qmCbshK5lRxwVADh0/Sj4PHKgXlrmS96XiqjGBqwMt8X2o2E3yFP729HNDAFUEhmuFks/O9KbNuM
R7r3P9UpC5BzQSpmOGnjbz9uK75SUN/4KJcSVquZUgctACsRkL1A8GIHYm56o2y0Mw2w7iCGsKq6
qrz5Ael3wtZ7GDRIceBA8+CGAE073MKdG8jflTokNObRVJ/WoQT1A22FuX6pxzVBW39P/QA4HuSg
Yrhbgc3fM10G1N/NPPnQuvW9CvdSM8trHe4NM9yJdeqgN5Y/MXS0WjcabJAzoql0D82QfaaEHdRy
cJkVrcP40fTu3Ytf1Cdy1TYkwCaMadAQNjaNdCMOqvWfa2c85JoGjZkOzGTx+Tb6ZXUA8SOwnD/n
e7+M935pib89JgJY8NcgVzW2a9Eu85Ky9m4ASD0wzaN0lKe0RI9foVt57l3N/LSq8vNfB4x3Ohje
RcbSScsn9gLPWRtlbYNhkRCnc11/7pxUSE0Auwgq/oFf8bsLfJEckIKAJUR8BlM6/clFbIY74qbl
32juH7h4qIs2UtyLnLw7WdwcvBykCtRBf/1V36nsL238Jt3YPgMrKwElK5prd7uOR+PyCBZCOA3S
LQUo8K+v9I56Fbu09aPTaoBLQ52ozQ2QZFEp6k8E3/G8sgAPbLsfvRbhYpc4KnsWNYWLcwCpack+
OAfe68S+tih/Oi+BPe0GxlaRSJyWwFBg+s5CW6JXjvXUWONhsLe0EuGM1EPiY33wzd9pgV7KglXV
ZHezY0TS+4CqeE/nvavTzz31kOCsBxtL7zZWtLTypNWH6/3Orf0XtTDAdSCORHx4/IwqRB+wbz4L
g8YACA2BBYi3a++g7zxh/FCO2b4Rzu2SPYFi8we0Fk8Z+tGsc6Is/Wi49c6uutQ3qjQrRrDt/KSt
6HM6ZXHv8ENB+BZIYiT95NBZ5mCn/KPn7Z3AcSl6pBn0wtTU+glYay+QqwOQtNvr+TVeCZbHtOCR
Uo8FiuF/7z5fKiEBAZ5xS+AJ59g5hUMiytuIzU9pJiJYc5xmg2Zx+6S9LbGyfy9WXQok1fnIYRTn
W8jYp0O28kOJadmIHXwOi5C/ORAMK22cuh98x/dW9SJajZxWVScdK8nQ+jsHDIV9uqwMp7c5QKkl
SB2G/WtHnKf/vOafUIs/x6IXmI6LH/83EI/r4munevVj+P8A42Gf24DvIzyOxdfn7jkbn3/Gdry+
5p/IDkvQ3z3GPO4RGyAl+hO0wxLe767wkJ24hHBYpp2FS/4b28F/B1pe2D7KRIcQcU6P/sR22OR3
D3BCDAxgWWwTF3I7/w/YjvNB+T/pF7ob6Bv4xMUcEtdH9uf9enZDkJP6IFthOAi6G9pNnN97zjps
WNrIDyS2zm91cSmfcEBYXMcVlJOLHF+5rOUlmIqb2VMgwA23IE2iE0cf4GR+GDxr99N9+PNR/Dkd
+dfLYcltwOxcRFBfXKoSyZYIMxe827gje3BSETMQ94LCLivEl+p6xShp89dX/Ne1xBVxhwFu83zb
vfSqnrqed2bEFXOHV3CS1/Ey6Rh0xo/kjF9FBH5dSiS2AiKYNp4E/POiCcBb1ZWNMN1GZ2m/Y52U
MQCADJSGNjN7ZaMDDZTi8MBNCYhnMyW5me/xTn9MTvtUG3fbKLfHtHH218C43Q1x0jZ2KfATXMs7
Ptb6A5mIi1nB+TFzgVXyPdwOz8MKnY+cnw72khJqV5iybkpruHaVvgJ69+Rlvrk6GyBOOcG0G05S
QX2m1K1zP8d/fW8uSp4/P4BPKTYbFNT9S6n9BZRoKM8KCc5LV6LeXZQ8KCelG38ZosKzwBn3Mxgz
QUABMEmozaFh4u+XjD8TMh9UtljhQNavIBPMHxxGv562r58MLBDqEW5DANK/1IjEBLOEi21db1Iq
OWr+1FVZkDHeJ8PYkNBV7RrXrO3SYKYcyWfdOuz016vjvspV//xEIRAxShFTYFaOEvdScaNcPdCV
Cv9cOo3ZD6s0/I/VGI6JQu2BiU7XCkRRdJZODeDEX6y0e0jnFWxFIFyboKHzFE/tinWjgt/hZe2e
8BWAAOE7GyjKP4wpFFDHCTxcgR0CqVv1AHWsBFx6+bSkGzox8eD0aW7FGfLrIoZc0TSDkFN6NC6h
/NXGyrfW8YoqjRZh6kzkxQU7dLrLWGW/iKYqj02qNCC6xvK/dBAIfOzx16OlUvJiVjWjcbl2qxc1
zFsVxtJ6OQFfW2Pq7qdm07elv53Grja4PobagEM2B17XzdEDRrsLctVP34sVSofB7I5gi3l9J597
jGY+w/DIJAhDksUawutbOKyajQTOaksKTy2P/Whg0GNSYtw95CP97eKUMvFcdPEDr3Wbo+hrFUM+
tf1e42IPjFcu6CPQ37vKtd0HrSTDD2qWUgfSFukR9AH1aDJ0LFogcpzAaY3mQWU09nMxrZPaVqOq
rljnDT9yCsdb11L+IyhygBNAN6B+ajw3xVDKn69tb0DDwa5oUoHmoDGTcaaoAfOFQ4ZYoCnUcZ/v
c6A8z2oLyuzATLTpBs7fkxXwGmlNWPlg8gQaEOptTkEm2PazcChYfS14j7bnXvlrLzHgAKrvpS1y
6yYbeWuSvG1aE5eZh5speo84cbe4kIJO0ZsYAAlnswLSlpTDvtYEdmlZ0eJLciEnNxrnAe1xDeKJ
TFocJyCeD8AiqLxArs6hqj/pVoParyWoobQoTLajBiZa0QS0z2EdXXgDNp1rd4HDhk9OxksSpaxf
nqmjyzEAlX/Se9nZPjo162Cy67XPrDIiJag2i5TlbSqd9gyQqK2HTIkFbvB6WKIGdRpD+22yihe+
ghoULm7lrpsaJanapJ3HbxcLmgOJyMb5qPqi+tF5xvkuhhSKlsB2g9OeesUOnZ/mGoC54RoLV/7o
ALWPuRGn1AAHxarsky/8a5nX3rfVb+5b5vJPHszHDjAigt8Mw9QjJV1bhbXonJu0XUBag4d1UKy6
2swTyyMFrYhb4095Yq+GxlyiRQp8DYNwL1lCUznlAWK7U1CNDt8KNnVR7owqKGlZgbXkq0895kzP
adk8Wgu4sZSZCmBq98ziBHpgnLwXkolsQ5cCUGLXpOACKRH03WDdZqkAH7gUcxsseYG1NhCpmJa9
YK13mB2NCU2OxlhVdF1SKtc5ywtQYLPso7KAsrfoeGPs8cqmqt3Xvr/JynpJStIBL5QP6261xb3l
SRHQHl3cCaYn8FqwbsBgHQIO/Hm89IOdAF1VJ4MS7XW1FM2GzX0j0Q8an6g72WD40ROdyx+lDVSO
XWQVan2LP1jEbpNy9YvDUsoXUJfna9Kw9QekSYtPNeLmUwe2ddIVAHFOQ3MLSLobMA+WZUHd+XWI
Bk0TAthaRK03dHtWl+4WJqndFl47Fjaugy0Gq+r1doG5Shu1jmsXKParR4cTtnGzAlSvvI36Vvk+
euc5JJCJrJG1UdBGoNtwNxcFB99YzP4D9bQTgQK3b6QN2hdKngpPVd0dq87KMZaDDZlTfHEkdZAa
qebgcuk1ISlX/qilLY8pZmEYqNdTbHNP76ccsxxVnNkMs0KPycxQV8iWTaOq4tjUxS1YJ0CLuisy
yBhuex12dDsfIRo//sgt8X/YO5PluJEtTb/Ktd5DjXnYBhADyeA8iOIGRkkUZsDhmLGq1+jX6yfp
D6RSSYaUomlR16qsKzeZKYrhAcBx/Az/YBzDoWq2qj7gbpOO4mMnDSbmejSnW1toOYggNFTaIfIt
r3U2UF++pqZwfFeXNcQSKcqFiKpsawQWvrUR9xqJlJQZ0TzJfOcMpBUrMcoEysrdWMbRWnXHeW+O
tndZFt50rNltHZSemR5jf2vcxQSLbRRVOgBmRtBaOzq+U5dfMsuwzwfNLbZVNTNCbuYrT4minYvA
j0TOAd6vQQ3lQ1FM9nVJphI5hgmPWEz3sOvK47wcvc8MoccHNGTmtedYTHeRVzD2AIhhhsUJ54or
ctTSC8Oii0BWyBS0vakwL9loXTicu3ne+pg4p+u+RniHEeR0NMQMmhIdXUZfDzFAiBzP2rRjU621
dDZWoRF/knFkbLOmm6Hiy6k540g2v4yJVwEKlfVeLfJm7SY6M5kx5PPjeN4mCSQu06g/9+V83Ffz
YyYcC5JemvuCS6joB39uCE9rtyivPBiiWzU3LmDz+Hkcy8cCyaxtVOuqn4qqOYKsutb6RF7MsX0u
4uG6bEb9BIWWL5HhAt/T53qNa7QVqGE2biINOqYyoUTRC2dlpQycCqX+POWDPEf5yDsK1TyYvf4Y
w7IvySInAHBnWNsJ53ZuD6XP7XwooDJezBOwLCFa5Ul30quotFaRN7e+cMGdCI2zDcnj5MmuhXYE
1jneIFDiXXYyh9qdMM7z885zg6hqKYc9hs4rVRCocqwuGSDA7w097fOk191jrMfMPyerGc/mTHhI
EbDX6YtL855swz6bebtiSIW8MruxS/PbRGlRb/Xc/kYMWeRLtzFu+nzxQXW97iJs7U6sgSTLIK9s
71ziPLHq+NLXObJkD55UkvNSk1nn91WVJCdzxRRvmGLv04zNjbnSQgRoVq2iq3e8CQlzMEPKVa6U
9RMjA7aQF1vt/Txp8aWmDOM2EWHkBFVREhSRTdBCn+0bgj+A4KastLlt3WAa3ZpcIjHI6RKhJgLw
jutoARVqJn09i+oCKUCpnyNwUV0o89ipWF7K6i6Eg68GwsJ5dIf0ElTGCYWImwqSfs9MbkiZDgJL
ujOK0mxWsSubb03XjWLhelfWysjcpFpJqLs3eT2T68Uyf0BwuAtQSScKoeqwL4zaPEvquTKPM2yJ
w+OqSMdmaxfSOnXdJP1q52gQrCMvNo4aGLb7QsbuTmA6f+VNBV7RCefzx5QY4DdmW8L4rtZGYeJd
FZumREKmLQlZavhpAmXApCYcTpoUIatBRIIhVGt+zuIlwwSEWHoPkxjcb/D+xy27fL4cnCjcMeRL
tUA00Ln0ESRSw3uvbfqwBx4us5x5dV7OieV3+Ryt3SmbLlI9svurxHOnOICNXXAE0hCC82vwsU3a
+zD+PMGgiuHpTJYj/E4nyFRtmu0zx01HRF7K8X5Brp6qdWfFHqIFrYrUQBqT1MZGGRe3uZOPXxxK
qyfRAXTRIA97QQu3/MjVas9C8SjKREBHSP2cNCMxnDSpuq6RBIgverkEg8rrJssnbnAKT5XHswyn
6qrO2RDbCf7WWVuPU4l81JivU30o17oWN/cgRzxoq7AM1/QvisBGwOZSo0Y4Tqq4vSoTWMf5lLd7
Z6ibj5DpSJacZmYso6r9eCemyZ1JqroQNaVoHi2/Vr2qOjKNCkUpq5ghrBfh2CPAk1gkYnK2Tpms
IMiVoGq+dr2GWTKPNt2gJaKFZ30VT+HKiZEqeiLCS5BpiaEV7tYQpuveqA2U07vWUtKjCUp5SUGI
jtkqH632LksLhLUdtwAqZI/ZVa3LQV2ZU9ruhtro/UIFZAQ7fOKLApGZoflmqxEv1G2vK5yBUsAQ
NxB5OInKhqukFK+vgfA3n9K2LdCNGhLnm+5lww570F2N8cO2H9XmFhPibuXgMPSxTUSy04e86Hw7
b+et7pY4xUVexTigCdcCeu4uVpapYzcjZyqnnjPBc1ZRKetNWCEY4YVO/VUPixZZmT4qeWU69WaO
ne7yuYb8t/X+3lDC/huRwGwc1yjbXxXcC9HsDQ3svGnpY//rGo2Cqn0s//W///7PF2bY6+bhj8/7
Tg0z7Q+eDsNL0x2UnmkW/qCG8RPahgwIHOok91n3+Hv70DQ+uJTWKhqc5Gi6vvS5v7cP+RG9I9Vz
XfpwBr/t/En78BAUybTYMtG2VpFvsVBqUw/lkWka5VXEK32r1NpHc9KPZVxeplID6JEXQWoZJxrV
AJ9zolPfrJu8ejKn6Tp0qztUMk61Qkn8tAEMqJziCnEVzv0maoU/lANSUMldVs22X4sx3dhhurMA
C677qoPNUEWgAqfrSWZoBJR3kF6OnHp6cCvrBO2pmylJgeEh7bfyZiPA967hjK+eeqSLSLtQmrda
74aofU3usU5sZddHbgOARS7aIvY3Bj7nHUfJCLkcfeabylFuVNdDzQkMsZvs6m6RblN2ciw+FaBk
sNUC/mNU4SrG6tMvsupJ6mhriY4XuR3MDrgThmlW4tQrFfIGimstx/v0gIgGvzNmnxSm3UTvQgTR
lHyOtPHadPjLUrN632LYNvQAVCKjunMHFa2fzj1fRnCNpcWrTH9W/txBPt8MhXPXaGPkxx7G8UTi
jWmGO0/wUY1sDBSghmukIxcFXv3Ym8Jv+gBVBBmYlYI9zcrzuLfj4uFQ6Eu6UqlAaFD9VCWT9SyD
7163Sr/FnvFSp3uAkMOzPMYdvwsU1kUEwnb42MrY5C4SDlbLH7umcxZXfbEOEwAVblrXFKf1U4pl
08pTYKEghpOvHDPWVmOEBE1OvgTOrr5Lo/njYITrSVXOQQ2e5CkgFtrUV8qgfrEqsYCyzHql6Rq5
ayOvtM6+Ub3ujHrNHKYnQJ8XSZR8KrVsEQApn2CE5yDHNqlnLeTp4mkuZBSorlktmIsWYDgHr55T
PIsm9XZjOn30UmM/peOD1UWwJ50zNCqovwzlWxc3W7RFryMTPFwzNSLIGyWhUvd2plKGqMrlDEZD
ZW2l9VWtKTutVz/2eX2XaUARnOoOnvFlOHenk15eUSAn/lAVd+E8XeteHiF7OF8jOocwSmUg79Tm
Ph5c4SK65vl2zFHT69Z97yJpoIfhTgX3aMXm3tNBKIZNKRD0kk+ZxhOW+okSZ5e9F5J4QE024h2E
rWPc3J96N9tlrrZ20+JUS5ZHELqXo9mXK7eXa4fTRXF7a5UCrO2demvXGgqkQw88LDw3AG34vGOf
lLTd8vVWozV907VmOfd2aprvVJjRSZN+CoX6MJDuusC4uiG/1KaR1viQA0DovJt6ML94QgNfax2J
tnj+aohegrtTvmWxeezkzpFQuDnmoO1NL/48qdaNZmgnU19EwTyYx7ma7TxDXDXZeK3Wyo6qaze5
7ArFjD/HirhS9fGhImXrAe5wZh+run6STvMD/YWjzJoehrJ4GoV+MljkH6+C/C8mEAccz++x0bJ0
Wl6cEI52MFxhspNY0TDOt6Wb0WSqxX2q4SHrlkjmiOjLMILNcuzNHJb7qG3u06IPwPG+M5U4QC28
fAtrme/QXwbpejjVR7YElpGUKt+iEGsjChWaihaOJDRb9Xzv5dV1KiiptOhETGTX0rjUo+QbZdZL
D/6PMoR/HP29Of7/8W8ta/0gjv/XIIE7qgvNmgP2n4eEp4/54/T4r5MOMYz/+x//p8mW/9vK6fHr
I7nA7vFzVTwmvyKJ//jsv3MBDnVL59xmTgAl/O9cwPrg2iZNSdgxhsm88ccokQPftlSLkRSzNxUE
NvPMv3MBg3EI40WX1r/LkOxPcoG3cwzHY/JFGkI2ZOu2pyOV+XbEg/yPzPVSlbd2COmwVk8K06Yo
soNK7QJ+eZMVYptW72kiaD9t8GVhj4Eb7xlGsO6hsrztIUTetjRzUedZSyTiWtO8TbxsreScQapW
rGkEUJjO/Slc5J42OebnVYNlFp0Yn9xgO5RZ0JjNMW2jjR4XD+jkrGOge8jTXKXoGOZpF0SqOBpq
cTFUn7XCQouw9O3Iuizy7KYSn2MYHHZd7NFcXjeFfZNO/alnE1I8APrZSLpeggabx62R2p+ctqAv
Z3o3aqs6K4MWN3yWFCFEsaUaOfPmRcIyeTQiqzvqpXuDDus6kuITVc6tadKDq1uapMnXmIMmi6NL
W45Xvd0BeAdM4afSPRty5wZ/8KvlI0lOj/qBr9Iow1GGdMTg9SEzmzDeMK0DGWoGY8vNyprNgkoY
O+U4BXnTMlhdg6zdl2r4ZRK9PKKnuCuV9Cs92nSTZaAYnEHcM1lYC2N+GCfygSZWYmglykaf+7Vu
Q52FeDWatAUc7MP81rTPuhqMYykzOJVZQNhEthEwopM3xwLQTWkWe81V1uhcoKM6rREtewfj80ys
+3vU9bxPddVBaYH5OXvVOxie1k1ddKOmyFvVbQJ1tE7iRTKvniAiWpdTiLSSYQ/neprc9HZ0Env5
2pQ053PnjMFH0MbimsnTpp5GzuOkuY/y8S5vuV+V2MaKtQNnHaRzuI61PrASE2E//XJuxTYJvaMJ
yMsKBZ+z0q4vqnC8Kxqyv5jHntp7eGP3mMYDRwmhUo0ndVnSwUpR7+bpzOxiwIsBerLQdrXuSrWW
DY6EZIL84CpHZzLPAerEkLLj/MEB1pvl1r5uOLDphD8MfYFQoEWS5iyiNeJTbmEa2mdnjm7tOiO6
9OziotCdfZqP55Exnou6vvbwJs5z5QSx0Ns4ARvr6be9jDYa+cgUFhcOr8kYm2eZLjeOOZ720RfT
QVe0KC4iwXdFpzf3sqDW2CEamIK8OHLL7pgNuo/n8B1TDO3ZiP3wwWoGaoUWE0z6JQcPtkeMqyhx
f7uVqncjbO8mVfM1cNbN1Ml7qZZUFdp4nozWWrTpacsUQsjqKuy3lVki6T2ep4jnyjrdJ663Vqto
g47uShf6qUD7ZyjFhR0qN+bUBUnu7AVScZ1hB2oO+FzRxhNZ10fWaG1Npz8tRnSTSdwRglw3ov0Y
EgmbsPBjw9yWvG+pM50kWe8LG6XnXB4jtxAYMv0cxvl+6OnxqXEKinO4k24aCFSd6Veuq6RY28i0
Zm27IcXeIlDGlCXy0cna9F1PZo5M2LjcenEBcWKH0uSp8Ggl4Z1SqtnaIQpVLf1TSDiR0Z8XBhhk
oPYM4IEFzRQLDcPx4bTw9G0p4tlvtcKvGcDwSgDD8s7i+g4J7fNwELsq++qhUzgjZquMDlpwX6TO
JejoO0t53DUo1dAnTEn7l3LqSBhE/lB5Z2p9wKF/eZM12L0axw3p1aF9BrkTivaJaG6516ddS0iJ
MDSmY9WY5a4GxOgN1s4No8vcCeHBeWslFagcdgGCWtCH6BKX1SczLdY09RE+z6udmEnHDLlBkXEX
MoBqhuzMLbpgrDoaVeWRbhi3dZh8Wd4SnfeWonEj7d4Pp0WLzT2TjGdeZQq/SCJJJF6hZl6u0aDC
RxzG1A2bI/oNcMLM9dqxs7m9RbS+RitWbAe9CyY50GgK03di4wER/ftqCK8uiCUgy4fGO+h0G4oY
OErNqj22imrjrJzAoB53opO2tm5RYCf3tvYS9ZcRHyS1K2jz9kipO2H5DmTj2Xvv9ftMa2G5YHrM
KNLS3jjAjBgWxBBj6IfbgUJoTusjxQPduxyqdWnDHrRp/pNloAomHXPXC7EbaPpDFtlgGRioWRfY
lX2WtsZZm3OijuFx3Dn7Kq7vx7Jk/B+d1ERUpMqO6HOeYtd8YeneBZChj+YcnfS1Bb1Lvy2U/spu
ucxy6j4ivHdmKOOdzI29rG0mkNHXoqi3PYB5kA2nam4FRpY8NZzauj2eNymLkAIVbnmdTbJf1dEk
V5NTNz4+QXcafwebHfEpKoxLk7+wwp9gXenKTaPa+9GIT0ReDO885GXHvL2tto47t2rQVaI79IyU
eQXFwfsV+6CY22orxg7U69bIw//J9JF7IrPl1fhtpy8g8FXk9DeP2VMTJ8UbWOCP3/+ezRvaB1A3
pK7IOC0gPBLz76JPy0/I5sFvgMYhLecRfu/sGc4HzjYHlSjqyiXTBzP4PZtffgT4HqNxZtPgA+kU
/gEw8LB4dQ2gxy5dPRcBXsNCZupt4KHlN1cKqteXUfEN1upIkiqzJqD+8Mcc2XMZgbkgMOTAY6Ai
lqF8J/Id5vU/fYMDwGActpnhSb4BKgmrHNZnA/Go4kQcTqcjjJMCt75MMBu0W2R9MYlWvj6H3v+E
evXmfVmz/04lLWWiChGIXffPNe3JY5fIJHvduf771142uON+cFzHsVT9pXG9nM8vG5yfmDSLTTBv
LsJl5gIH/GuD62xw2wARZ4FHM0Hs/b3Bl/fFplAlb0fPk3r1jzb4Qfqg6BrJqE37eoHjvwqAIUCA
oWoYLEc5gp723K5UpUFrs88/Z32+hSS17dEwwecC5wfnKEEYqLOL42pR0AZjGWmXQwQDKe1tuQ5V
JAoBBe6cXE/Q0QAgBNak3OJet9KHQj/B2kL3+Y+10ZT3mQ3e0Lts+2bFjHLvaHKb1crNbHa3Woaq
eZ1fzIzU6KSmse9k54NSUogOse+a6Dy7V7oVfx1hXa4sp+PPmtssLb+gKHkUeVq6eEuh02PpZ7bW
7NuUfjMgoIW+l0YsV28i/BbSToE9zcAB/U+bQ5K3SvOwkIFIjYbhUiRGzRPQiCsvH7Zh62K+kUHh
FcnJMLQf+2g+DyeY5vFXx0t8pVT1tao614tITJveh/G3rim2c+neY8Km+86YfExQHzcssTa7/tEK
4UOp1a009a9WCp6JRP5SU+f1hMaaVzXpDZgt/VRamXpMQ/F8iiRs0ghzEg9fjJU7tQ+ocqpHSVtp
a9RY7wphnc3kCMe2bYl7Z5rg5hZpv20LKR96PHt6fZxImKV01k5SNQJeKnaZYWSb6Wp0mTcj2L9d
ADMag/DGvZgHrT7rgAxAvWhuimygJ5Cam4QW2kkHe+xpChNBSqAnt+DI0h1AwX1OsR1UPSrEDE1f
mnf/thD0X7Bf9j1K0Av95+By/VhGv4gs/M73yOJ9MNE7NFXTtg0aYkuo+hFZaHLazLdo5Jr8+9XR
iV4iNC3+ATZtWHTCXkcWmmBM3jiGkepCZemPIstycr9KsV4iC8eXSsB7HVmGMEJgtE3CraaP9z3S
1Ixq23rbosG/zSJ0JlKT0YplJ+VxMqNAD+KuXFUlhhZdlKDm4JmdL6KF9og0VFBPaR2gKg00zCgf
kqLSgGGq83HtiuJRRmF/lChhsdGsuV2PBNsVgxN7N0IWBnNnjcaqbRhtpJnFXk2+1LkjN3mki7M8
61A1yLz2MfGG6dRQ6bWQHScbUUP3XTnSHj5PQ6sedziroISPLnlZM/yXXU8oI2pjXNMD3KwF4Hpq
CnBnhYlGlFqlcMIB/q+G0bUvPQxDVqNT2Xd1ond+UVkC8Q5MCqZhroKyGyAGaqH0hVcUvo1MCpEW
VSAAjx+V1GvRZDKXcVo93aGKjjRQEk9P9Is6vCUcql5E/v1SRW9Ab5amSpYiIYAaNmNy8Q24XstA
i9dYBam/YHYdbVU5DK5MOgKTCsfd0irgojR5onxyl9FHZ/uak3Q+TMarHMOANSCK02HuPC6iRhWq
i4Z8B89xhDQ+R1/zlp45ArHOlVuG09auhvnU0qc+UFo57sukGTaZUykb1+2bYzhdu9LW70GLgolo
YkzNzK7xRasKDABMNCxMszpGrkLoq0xmzqYbZ3erDeNNXKdbd6QwKKqs3HqmPLWzkYmgjGI/D3sF
eZMRmawRNINDIR5FzPbpFdhDGh5NToQETYcm4eS2BdYOOfVH7yhMMMdoV9OXKmyjwyhukPuuLTP6
iAtoilEZl5h7D43RGoT+zjiORjIwEwTOrg9VcdfT97vue8YVcdQ5tIfokK9AwYUEUeZ5+YDfSjom
8q7rMNxwgPOvTcUudl6h5x//vTnaf90ASVbyzwFy/yja+DH/RYzk115ipKt+0EmhEJQ1VAY/jvtj
WOB4HzyDUOi4pFL8i2j3I/tSAQ6AM/Bo7lr0ZxdK3l/lhfrBgrqhwRHQbU03CG5/Ul7YS/b+dxn6
I/s6HIo1nmdk4BuVra5pNDQaQSPDzQCrJkelGAbAnPGnkm1jTtqnkfpk1RXDvh7FkdVzfmM8Wvud
UX3SGFc1xfgJssQ9Uv9Olx27iOZNjblNu0tdMvDuteJbWMw3ij7dx/Nwg11G6ffeHMxqg6ZrK2w/
apLGb4z4rAqjI8TnVxBr4o3Xemfd0EQrz8m2qBbigu0wIRAT83VlejRjWOa4wgWZtPezkKtS64Q/
59+8FAhilewBfj3krbYTaHUginOjN7bnG/S7fdtVdzYvWZv2V6WEvqDJ+7ixv4yt+WlSkyfcmU8m
Ju+rRNc/pugxdFINutb9nNfkbcYyAw5HyImdg857HjR1zwsaX4+E4lXj2qumRwJST4cAOPxjlWs3
UTRoeM7Ip8YYrvIq1E65WSWQ/pWCmsII0M6dM9VHVv4UTDhYOdC+gIccuCaxvZnq/kzVYnS9Me5e
JUn0VSBHvOIQAhSubWuBBSWjatj6s8J8U1npebsy+AxwC1cWQcO38gE5Xbu9dOfKQ6TnzFMy7chG
Qwpvkvg2QxjES2Bs4KiIqKW24pA6KxPVXUO19YIZR5L1NE3trrJxTQCg549qe4Mc6bChGd0D9mRA
vq1xPtom+K7uQT4CzmiyrdrTtcPLp8ekTFpfgTdGGBN+icfa3RF/GX2OhrJjdoHwXT/4uVAvvIYJ
hdBbZNPzSEJUqct16uTZMfaB9c7MMEhCldf+FmOS0qeT98Iu//861SN6/HMMWz0CFU7eCGovweAl
elkEIh2GiEOA8pb2yI/oxU8M5pVM9Ra2kk2b5Ef00tG95mcc6a7qYfe0TAi+Ry/dInq5NEVAg5hM
wwlHfxK93iZ4jkHnxdSMpUKl76zRq3mb6FmKZbA1pjoAig9cOC2+AUpNHlOyzP1cK3lgpMBnMpyH
tmHszQ96zNhkUhgDzLgdvdMo5Sa9iqQvX4aGD2MPAF+GfihfOsAQwppJk8HsuvWpDbXjXlRFsbeS
qdojlp9velup37Gstn51C/TnLhUT16WjeHALRDkoypiQoYq5o1JOOw+4SYeQWF4hVxdh+vqomDVm
EBiFFP4scnxfBLpEzBPT09Tq4gdrMswL0sjPU5WXQW0bSIkKy+jRW52BD48KnhZKZCqfOqRoplU3
IPZBJkj0S861WYz30JyBQo/Am+70iNy5cXplOzltgiAINpcg7G3MRVdthCVKQlvtepotrE3UpVQf
BnnpTdNVhlv4gBrH/aTNZbXyjI5yPy6z1peO0z/lrmjBXKsm5bRuD9M3zXBQRyuzggQbc0H7YZKt
tyoUNVVXr16Hi5ez8DWD9Xlw/fcR+fJgFyF307RYgNrl7S122zlPlVhI7Fy6tUYPQecOTPhOrQYK
5lYJT3uMbQVi0Dm+E81DCajVia/qnkmwGm0q5zpkMOdsEgEMLh2PauzLOuS8BH8MHcEPswSENz5/
prszK+WdHbK8Az99exo5Fu0fEoqlU/m6GJrrrK2iFCU8M4uiwLXbCiWHpNz+/iYtn3K4ik2dR5+U
wg9Q49tVNIe6oJBo8TlTCeDN4vmW4WVXoBxTPMzOMK/yOqn83y/6bH39ZlW0+Be5fovLUy37cE4S
GbJJhd3KwCjrAtZLoe7xTIVt0yfq+GjpqUGpYqKT4WkRmssGILGw7dqNrsackEUcK3sVRtXHFLvJ
23hCyKJmorMd7QkDj9QF5/z7L2wsW+XwCxNLgUe4OoMyDAHePIxU0YcMeTNu05hNgTSG1reyHqU/
RtMrrKqqjWSa6c996Gxstcs3yWSovqLCxKk0dzyymnjwLQVmhaHouHJqOI+2umh2s6FkQQFoazsx
yLTsBkRECzJ6Ga0UuuWcapUynA/AlKD7qFctpI3zLI3KYDLL916YnwKhpaoaxwXDMnOZZR0MjKxe
Ae7SDbS8elPudFhkNersfqSb35i0BK4zvydYdTCdI+aqdDfh+7MaKBr1YI/nGQTTvmBFIeXNVEP5
mYhSQaZAUmiMd+L8gSoK8YDVFiiZo7ngfjnI3j7EKstU2Zi09CzVRhfMajdQNRAhNBOFLp/hAkqA
aYSJyc52UbxPxm+/30XPMf3NLqJ4JxZxtfiVUyMcBCQsZCC4m1EdRLYXgX8sAOB16PrmDkbJYWOF
QQxjZt2V0ll1de35lVEvNqI4+bUtDGKRzc1e7T0vqByG2EZ7AwRhWptp7OFw1SLHsRgy2lmJiSbC
+RSq8cCn2QhTNozMohz4XzFemm7KXHnQlIuihLcaA/VYD70XXTWp4t70mF9v81Aw8U4livFUnWtr
jFHOhOlS3bInVUgDvS9Hun5JbqQnI9/tLonr7hhHb/BBDo8Oa9nxhQT/n5DhnYun8rqVT0/t6aP4
7yCSsdDp/znT2z7Oj//iehLxtmDll16yPcP8sAgE/JW1PU/yX/p5/ETXyP4cIju9JHtR/v1rUqB9
oPFHy46qFB8WYzk+/6pVtQ8w/dmndPPo9gGY+5Nsz+B7vQ6eS67poNOB2wvfEKzfQVyBumE7ocAH
rLFyzDE7xSnPeiYBHjEOY7vxWAkNfDQjlGwadO6jgT9ybEvuJJkQLI+4NiK/yXTjtOl1pBlqD8t5
uDs97WhjblaYrKXnDSb2GyAzkVwPWJFXAS9LAVt3VJTzRkUoMMwVxBKnEpdbSELggkJha9Gu1buo
xTWW7mCO31m1eX5S/7Np/xemO7/btEfy8W1tsvz1l+1qG9QZ+vPhj+vj0n/+q/1smh+gQDiLjw+g
DfsZbPvXdvWYhtGv8HTLU5dff1OcANcCimaa8JSWX/uT7Xp4CloIeah489L7QXPmJzn/cgZdlNa6
vi6yToTHPc5VJ9i+aeFudHvDe7CqSuBDXEatqryTZiz97dfnw7I0eEnzGa9BGXZwPpT1nCQZbp1M
e5I0UMp0uhnMvvG7fnHUfvU0Ll4+9XV2fHiZnPOL/A3gfvr2tLmWl/bVFK8vGs0C7jYFMR5em6Yx
UJGV42Ze7Ii1uhVncZQOfyRh4xjPa2qsZdg6HbDDZNNSsnGs8FgPmMcZQBrH+gl59+ijIjLlLKvF
lS1d85012WVv7umypk6RaZJG07VbmnWvr9PqWkdtTLTOTRGhRRu2KTrZE2IeuMuN+TUUhury93f2
VyuiVASkipgHrOrgKQ4TUhl5XE2BNdTZiaHW6YntzPpGrY3hjlFp904K/4v1lmx6meqyXd1D8bUm
Txt31uolLQVv2We+28fxmYT1fmTAG38nd//FvgEJDzxZZ/RrAWx4ez9l4zVJMuoTACHkaqsRqTsl
P02KTlnZpbUz3Pj697fzsA7iAeKF4y3crUWH6FDTjqFk5OaQPoNEt2/xsfCOrXkq3rmHv1rEBqnB
4As4nHeo/68rIyiTRk7BHC7yrM1QQWGeK3x0fn8xP989hz3B3H7JBGGYLV3dV29dnYkaNSltwuNT
zu3WlkWfnBt2pUebTvGA2IGZjPOTOaU3awV/tjZhdelaa8DSlnaHcZD+6kValDUiNEHfQx/vI9He
anGv4jaj1asogco+l9zod+LM4Z1dVoU8QWzm+OfxHewXONehA8AFXvRYhkVg2qEt/djVonnz+8v7
aSEiGQHUobvOXnGfG+avbm2r2LKKHWsOWoeB/RDDo9MLtf4jC8GldmAvWuDqUPtaYD3Ly/hqFZS1
h1yxYhVIGpq1GTweeEpRrNl/+JqxDtDhZVLAG70s9HadvrZFlMI/DazOzr6CwwApYGnFOYTg7qQ0
LMenzG2jdx7Wgc7U0jJZ2nLAu5exsMrY/+2ybhfmUZNmfWDrW4GdqUsV0IxbWzd2DeDsIfVwQO62
qvHeNjl8MYCSuDw/i44YBSjvyNuFzW5qFCD0E70aI9oPMNUDqo1pJdySWWmEvSfY8UlrL36/aQ5P
XIfOCvhIwySrYMp2SL90SmyBGaTALnLlZINUN2aaZiluvojzlJWS/GlTh/VAhurU1xBHCDVvL7Oo
IEDXIT41kcTyG4ZatQu9LH3nVfjpqqClom+GraHKdIrR9dtVnF7jnQa5HThF754AF8qfFFUZ1/jU
zu8cdr9aymDLEFiQBuMNf7uUguI+DC0E9o3Ya9az9MYIrviQyFXSclK8sz9/ese5MNI7FXQ6ORo4
hberdeZYtAmdrKBx1OxIti4cgniU76it/eqaUFvjHlq0xbxnYO2rdxzSeWwps+sEVC3Ol1Ktqi9m
2mDPnOvvytL+ei0a67xuoJT1g0eFfsoIPN52gl5FU71GceMUClJyPPeo5P9+r//y5i2gRyBbGnk0
CfTr0BU52ZzaMzdPj7DuocPR4BZfNH8aIJdHxPukkXYtFOqDvFJv8Anu0gwTC6evbvpSpMdFlJbv
PKLDnAd49ZtVDq7FRtQCoyC2HaLsykmUcrMm5MWCGTEX2kdxfvv7e3cIpqR3tCxI1akvNYblHjwn
qZghxAJunrTb4VaINMFMozJOMiydMbmDc8BP9Y2bNeoxIHDw8T1+ILPeMcrPsHiJ+uwdwsay4uti
4fkbkYKBZ122znO369UujdGccaaCneM0fbFRNE3ugbg4m2YoY1+q3Vd1kPrd72/D8jb/tKYFSYRi
yzVJAd9uoa4o5wrzeGwMDN1YqYM1b71cKbZodCh3sKuvorAbTtsci5zfL/zL1wRALXk5fHzOircL
xxJ3IqVAwNioe2OniXxeJ10/+3miOu8UDEsI/vka/17qIES7/4+9M1mSE0m38LvcPWXMwxYiIifl
nFJK2mAaGRwHZ3Scp78fUd3XSmpZyarX16xXre4kggD/p/N/p92aSm98x7nUTERL58mdK4gYbaBS
x5OXsE62576y3FPndd1vftRfvqMB4zlK3ZBp108X74AFAbvlR8WkoLqAL+ldmDFpD//N3fy/q/ys
TUZEH5Z6wSds85b1xp8ZyLdJrLIA/tRv8phffqH9yOZEoNe0gx7+eug0m7Z6kiZ+ODdZLtoo6j5G
+Fo///0X+uVzGQaUCFTse5L241WsuSqCoua2regTrxNvi64XuHCvK0TNT50T4Oet4C4D6XF/cyt/
feU4ICyFvJE/DwYg29ioU7lyo4Vj0rJHyxralXUK5q68XnsoRSHspZMeFvHl77/0r24t2S75Ia8E
st6fguFW2crS1sKlvQoNaYsEqmKh6Tcn36/evL9e5adba6JR294I+tFSTn2iseZnvYMfOjCC+TeA
+N99oZ9CxySBZcYlb14bYYxV93V+GifMVP7+tv0qdEQ0H2hCJPRMd7bHX5/IqLVHfMf5QggUcLp1
/WU3ZHEOTrRAm9libCj+/oK/vIN/ueBPocP2BhtZhRsxoW2aLy186YPIYXOMevb+i7eNzhUaJPtM
JP3px+qZfM1rQlhchsH7Eg2LuRr0+jvPxV99IRopbFEwLmJhdv/3v0SefvTLHg44Ah4/QYRsO/mN
iwqRgWlcHv/5vYtdljx8anKXJvWPlxpKuyhVV8ds88UqraTVfY1Yw7yc83L6TSb7q6ePTnniUKnu
i+M/PReAG7eBegBGvucjs1Y9zl9WIH7zMPz6KrBe7F0BQRL74xeKExF6SCTh4ecqODlerN6YTs9X
f3/bfncV78erGDFSwlj8QmaoOeULWAWV18n/6irM7egkUkTsBuo/PAd5bFdwpFBv91sExWN1U0fU
1W8egV99F8DXIUNXykzq4R+vIpZ88zfJd6FI9tPELSRnu/e7xsz+WX+K+vRbibrM5vZZyk9XGV3A
/bVWDhZzdaLSgR3h9Zij/DoFGMgkv3lP//NqvBUk/bsIZm9Y/PSsbYEvZpEHzqFXQetm5RAriK3I
SZs3WNKN7W9Smv+8hWzD069H1cPeEz/Vj7fQcfHPs228Dq1BOidSqYEN6fh3rhO/+FJIx/d0lJ2U
vXf+41XGeGZZnI7joQPfZ9I+Ut6QorQFvNOz2CH+8XPBBoxHi4I+GkusP9vuYo1GSiFcB7imHXyl
twWfxbSr/l0n5vy5f3w0wn0rGgwChARaWD/lngpJlFGQpA7bYoT+nLd92EdHJ7JscyUSMxk0g6Pv
iVffRD7iwsXTQ7ZIl+Fp7ebUEtQC/MsT/W63OnXU5f0pcYSdpF0eJ3XGvzkt+GoEfe4R864NpA9+
Gr+zj/3Pn2cf7AM8j8GH88j9lC4UYLu7afCoF2beWXQtwVIgBfX76rSK31q4/ny1mO2gkH4qaC3U
K8x6fnwYurUH7aii/NACbdPZ3JddA6CPGeUhxED3n8ZYLpe48b7x6uzy25/7VvNYVGigcK5Pxi2J
b5T2sOWdYg/ysJhb+bvhyc8vFMyqfY7psT3BDij08R+/XZBUaw92Dg+/oYzoQdih/2EIF/c3B+zP
qUrMwBTl0v7csY5IL/DHy1gx0KtuKvOD1UR9fUCaH30zsnbTIsjVx0DMzj9cbsUygbWw/T+Ed9oR
P0tA6P9qOsRuzjush0s1tvWV0mOc/n142t8cPvpfXyoqOf68j/gPgRONt59OwHGAG8zspztqt2nF
pwYjwP4ygpw0PFXuhvq/6O0VXhVAifclOMkD/Hlx3wxAqYvFWxG2lZsHktsk+MoUcBGf+1rknzac
wnB4s9DrcxB27zdR3CSF89IWiO9BxOVx6te5B8hLJvmdI0nKw1DqB3LcBqEbTZd3+L9OR1Vt9bMb
2+OT5SZ9iwoZBeJNbW9KgTpCB7SSVpWXZl4ZzwnHMXdtNICHmMJKvgTTrC+8vPKv7IaT71hFdcDu
VzIgq+jNneX235RrsTIfz5uNN3XpfJU17s3aGeuPjknGGzVGzYMGi8CUqhvKF2+u5CnykBvnfBIW
VXJ18APzWbBEXqWzb6ZnZG0dQLDFtC4mg62Tp0tv4Q3QaR/fcANTmnV7oUMIv5uEEKa2BXwp8jxN
p87fLkMt4xvoZBL5rhc1WWntO3zBtN3JsauPUTAPmYWE3E3N0EPKpPBh92WZu335QoB9E2jFUw8p
V330xyYG3puPt4bN7DrDRc/+EOXAKWufZohw3SATwWinGnD8fIJa7WFjurjAFiyrlGk5VzodOmLi
UrjTZV3SOHs3qcgqMssJ9jvVFgVUtFqz2xdoawPOUdCEPOWhRDSGY2wQvXpeo4O0S3r7ne78iJU6
DW6hs5xEHlTsdJ+aukUUI9iK/Y7avL0Z+YnnF8tpOgSJA9r/jvlWx2CxSEM2g9geKmelv8ktKp0H
+JxjC3TCDe8j4yT5NX92pC+5CZ9ewRq6eByDcGbNUU+Nc9t7s7sckXipy7xo/OHYswCDSqcrTOrK
3AlvCpvNOwQ05aLuew6d4CKSQWV/XWb8sU5t0kevwiut68Gdtuo4x4V8ddf6ySlNdzDdPL6H0h7J
HVIDL1V2tfKOxbT50E6WLvmyOZN4MGreTsvclE7mYg18qy03X1NUPn7m281kHgfW5qFS2CrUB/qd
aL77tipw7Gy1hKA8YSkIDb4OdYC4HzOvoFtOVeSUeC8K36grX22lPLVV0twVHbr4VHTriAVlP6q7
aeRiGSiCCuwdwLbmUIcukPyOkGtua1UJTz51VDC0WdYC0vFbD8wM75GGkYxxPULnDFSAKZ+IjQB0
XFdvwRHIp6qfwmCTvNmahY2iOhRYSXf3SV9b8g4umMVSErfDnbI1KOB/bFOsgjTBQ9VPUVqN73od
Y8sV4UlbfAT00XqXUdGyRBTWhYUQLZ7Geys0eIGz4qhHKNGFsUsGnUrmWWVXTEoW8KvLIemiLk6t
aFr4w25u8lMExC86hjHrrgc0dwmvmugTFFJs35183tX5oO227k6tidVDvPAmQUdutgdAzHF7yMOl
Zbq0Gqosry/CrzKHQZhZbOKVh5ZjzDnJckLUEvca2CveJVV79FDwqUNsW258LEexvbMKC/mk5SXG
Y4mzLtjnatbyvsJgecMvtFWffGFDJl5zXR1mIHDm0DmjH6YDoqI3pbNV2MNpLa5wSA+h/iYmeV8M
RL/DMLpbfNgA/FWkMkWDXritdXKIhnz7rGthe5lq4+XDsrkiuvCByXJsd2PxKUQNiRFHV9gMWUvU
DWlfVzWf1xHlazhYvQ3VSWvryGDfqk7InNcLHURWmeElBzscxHaIkfNm9xNMx97gvbgtbcZOn8Lb
NmJB5qjsET2mKjzprsd2iiFaVOFaR1eRdnSIytujPcszIJ1rG4WmONmyit4IU5mE7S0LYvacROxh
+f7qvpZFj+v15FXrdmR/GIP0rV3MdxuJRHm1sOK7npaywK1BVISsJVDs9Xrx6jy4vTJV5gzbWHLK
ltH32RHJHVmT519C8A8+hOG02dfeNGyMutY6qS99NS5dBliec6Srfeeb0vhSHH0ZALCKyD0zuJ0A
ofJWVfFpjZzpdUsmGEZxBV37ciJ0PApVuQSIju27bNgarDKCPEqwPu7z+E3OyOarJbooTKWjtZ/W
/TTiUwmXRV04nfHGrJmj8AsP2YTumDjsHJ2NrbtUeWYZWNSpRz8F+40Pd7lAuyu7usYXvLekjVFs
t34FtMQZFIdmhM7MRgqWFH5b1oe2WDHQVTLy4UiOVWIy24UQk8Z+TSo68jR89PiLLqqCvNEZyjBv
OpbDaH2wB9/7qOEVMyeR0ntf+1IE3NFRiAuHsTK4nGjw8Itf9ydKIpeFRu4mb5ygxoKgwvzlW2/5
eE1EARD+NBn8ABRnyB7PSdDjcEGdVvN97EBHSdk6pI1B0w5IvG98zPJymrJxBhx/hRjKSs3bqdoa
+zBITwiisu7nU+Dr9fOWc1jfhW45v803UbFpKUr90Y+AgIkJpygA4YrnY2oL+c2aORvZYJzK5LEL
9VZncQV5Hk+HEZTkDNG/Y7lrLeO0s0vi22L1/ICJTPAVNIuIrIsOhBSy9bbuYSh3W9WdZm42ABdh
+IraKZSd1mtjw4Jmpv0liFfPu+mjLmJJoN33wVsv3pLr0jalnwndxF3GK1ZVWbNac4xFOOds1mB5
wbJ9BKEb62CnuyuXXLBkSXMhIYWoioRCAh7o5WBgnXZDJ50sSvSAHUTOSX+1KMFmvRl1gCPeDE/6
uPnuKO5w8mVMn3bAu8yxokJo2YVsvP5x64NNzKjxu7L+HOE/0n2dsFXN6TyyXdpc+DpcNgjP1Dfj
9pFqyWWYihLFr9vHUW/azU9LsC8MH/N10IpK3nIGui3ChdiFFXlkdfPRhj6FgXIXWuHY7Fi5pfpa
NaUr3kdO6+4rEbPknIzISaIUVja+1Gs0dO1JydCYU9NWQ34IJjHOaVXISd3nboMxKh8j3E/4eqeI
+s03juupOEb9oFhLxjcA32RJA4q1h75z06HS5TcANzlbc+7aP9sSAdPJD7bgomXG0JxKRptVOs38
N6BQI/dWMtAhpi78nqnHuYdbtCIPuoUHUCcnI4vhg8/fto5xqawLKHd4AFlywuIiHshJUwBmIj7m
ctWPTT354c2qhfV+cQiSJ7+InO7QbO2mj1qKwUlOfR2sA5Okgl1iHDdmSAqyNpm04nk5NVtdXNsF
vitXc6dgdA7DUoI3iX0VvzadBVpVdVH1aUEAuO0WlAQ/XAm25CRmOXiZnumLZnoz8fPaTG0POLZm
wbmcV5GfirWcy8xz2SpmHa516mPsLslT0Zv+zgWHH9xYlbXcIJWB/8O0sYQ973kf6rrtypdaIWq+
YHWwvi/XkQNrtzO6HozWOxOctfOjlTQ1GSMNmg9Rs7oyc+lUFKfBcbqa+x377Yl9lfihNWPz3RHS
RJkcR5D9S7QBQlYeeyQHv47WpyZS7WcORPdFto5hJ8DNh+Ji8+oa8JPnhIxat5A963YC7YC0Aj6+
cOevxho7mwomprGZK6MuIaKr/Ij4jSXIjrAP4miwa4Ax0/Kw7qtzKb69+bfaDSdKFxWSufdmE9/W
mGh2BMk0IAtnNSCbLZfA3E3NSAmXO8N125ZkhcvoReoEcJdkW9ApOnhO7UEkBv2KYzwVjwa6L5b3
3Ra8AtFVmd0UnwLtDcdR7l/cDyfY97Dbvk89C6c61/zlvFnuHRgV90M8f1VTUh1oM9W3a9HyBSoQ
TgU+5Xk3PpS86lg5rNX3vArc+aoM55Ztgrk/hbIcBo6jGPseIuHI8tEynhinWKda7DBjr9/k57lZ
+tfa8p9X6qDdb5vkKA3mCoJavzrexbL07aHmPDjYQ9XHCNpdNr7nIrQPpOOUMgsOjk5Z509SxzZW
nKyNvIlz62qr4/Kgzeq8+DZ74Bt2Kdkwmfg2LqP+5JokeZcwerxJSBFYjmpZnpptbb2oqrU+SF+0
z1rN1qnCyuJlcPXyuMTSrdM8qT5iIED/J9gs3adrTfG6/2zDQW3xdl2S3sMzBGLJsRW9AkHTzxLQ
ZZaDfbzzA9lkbY+5dGfZuxO8fNnW9tKZlUSlMm1v3AVimh54s9NyM1u22N2ckflgeBHX/mvVNxVg
DVm/3wggR2sSCfzfvs2CfI1vQ4tOCc+mi303puZO1gnzPEaEQ/T7/rU21XRV0ruGmmi/YYHqJmr9
iwk0SIowdQJThP93W9LkS0K2oYTGPgbNgvtqU2FfRt0qMIBZ3Q8bcnR6f039rm1ZuE/Dwo7utxI6
+bDGN6vJ27fGAiWy2OxQCTz0bnI/ubaYw3w3y9hf6aV6n0i/vPNsC+sM32bbv2qw+m4C67W0PQzw
hqB9iQNcKow1mfC0+HlDwapd+9JvzHS0eRS9bfFOnog+LFSbON7YVwyYutdhpqG7NW19dCcrTs3S
j1Cey8owcLWTD1VfR7A9ITpk5ZiEqS+H+HIDVXYwuquuUOmFN80ot+9xDAFM9A0ZtWAlLqGK3rT9
MVSh9QS4Mb90i8m6qauyuqwU3Yi0tKo6gy7+0E3B+OA3TvVSVSFU8GUWt+W6Wle0JdZLEynOssV8
m9FonIg/Dj4v4fyedhTLUrOYoG+P4ksuiu26Y+D4pgm6Ty2pF4WFF6W1wjN7XAzMGdlWn6xCdi9o
fd3r1hrGY5/TcMC1MOQex1jF+KpfMGzpuibLfQuwdEDT6VRT00MjhYKA/upxS4bkxl/QumZ+2A7p
trU8wK3Q7rEM8RRTjGSv7ba1IFs41wsO0ld+iEHgLIJ3fu5ZD1vsrDDGfXUT2KXN87it3WtYqugu
Cl2sZ8Lom6x9YkNYeA+RyL9P/vg68x0+UX10QyYBaX1cm6RsUpZXQly36vHZ3eR03WzVcOnZ+qFp
Z4/3hkMVC5W8RmIceg8IMci6/El/qJaqSteNAnid8woakEchQlzynDKTCvlzSp0Pf174Mn/veEaU
1FC0yTIDjRGsuTuFSdr6zoZZV0/IrlYxkaBXwzpcDPa4rBnp2/zEXju0ujx2npais9cjHz8YwO/Q
VDhg4idM6veNZaVk8OPTqgOSVijk7k3Y0bJNlfa99wpuIHz5InQ/I8OWuGEmY34SPgz9bJvD+m4t
knZO6Q4BnGcvWxeHnl+rzhRHRJt5zQ6y9LWKvzgcsYJXLwS3m8xuc9Esa448C/YsxeXI3iudFraD
8M/CuyjTmIDdlYklk7TiGcIwD1C8f/JlSYs4GGpHpLIZapVVypudK9HGes62gJuXWmZlv16XC1AW
YZdLdwhVEz1YeRXGWb9ZuCOJ2DPgzl1TZnUd4ojS4En2ijGZg4GNdMKKGtCdpjS2A33b+X1kstqR
ydehs8bP4TRNDw2bYmOaWz7rkAun9pfWqmJxILZJ7zQNSc+DicCugJEfuSOuBJ3/tlUWRxtCykoc
tIXLO94ljH9vZ7ooJhOTFgqjmYHG8Wiavj7WYzg+twuWv2yyUq2kRN+JR4GJ3afGNXjYVXKIQMPo
CX5tUU0B/TDwx7ShnCIOHifj57fT6LBe0jJuynEzqfVdEiiMMdu+AFoioCO9jSZD27jdxhyHMrES
bwdT4SNHKvZ9HkRQQxRY1KcO0oO8WlnVQdytcze6BaBFhcOKbowLX5d3SIh9QaBxW0NKOZP5s7af
9/0HtcR8B2lomiYLjaOUk5a75xZAFdK4c6XJ3FWpHrqsiG+Xtomftn7BXVbWuQhp7gxmZdmRUvwQ
sR9nX/XLVmxIDQZ9qlnugmCLp0F9cuaFI7Jq0fIfkHkAV0jaGBtqtxlszMDs0bo0efDBC6RbHoOm
qMVR04WdECGz/50ZoI5QGmQxTceGc/td2Hv5t6Im8mQm7NunuKrG8o1LUseu0D6joeXTxF8VQ8nl
WESTzSNYlPkTe4RxlFmuy45ih+ATaHXlYd+CY1HxtllyGtk8gDVVX1yE5RGNV6dgL0yyT3UhFjyt
Jh8fGt81njjFebLcbt1APZYsI/0jFUuAGJXdIqJ06R/F2ajAH4Pkjmb3pcPlrPhe10JMx7mR7njl
0HO7bU2h5mcb7Iu6sHB02ouRft+1A9Lslqe4srWiQYK1w4EtWQKI7S1BcKg2sLbQQZMqzrxcWzcR
NcvXmtGNziIsB9sUB9bWhs4QR3e9aOtPzppA5ugB/GBzZzgAZ9Y42W/a2hb/XD+Y7mYAHNWh9BqL
J7KUzssyR0V0Mc1m8Q+I+cB54UEY0Qcs8tKky0BFdo0jIz/8oS+1msLdNmsm+kxq9d9OzH7E49CP
bX9bI+mB9Frimr2RvjXMf2MQzN97HIowX0pkV6W5VHaYFlLNzd7Pns3beGqs5thy1tGuDSNBncPM
+qGbG/gYmFqsXtonLouhUzH7+piEuslvexPAIaIriv9EmYfJCGdX7G5F6OddNFlq1KA/er1NVWrY
p+8eoolzNPUXHCUzuUmhHoxwBufWNq20+W2njqpEDrNNa9wTMxgibhobMT33KfcKGV2tC+w05BRk
Cq+G7uBymDXZ4Sno0J+1ac6mkP1uZc0cbOq6Mg+4SUxU48lYBMv0MI4KCDdHvrs8B2NMXXWcXQ84
Fa3MCg/DrsqH/qVuAl/y5FhaP+bGs4vvQ2dL67pEDqau4xVjghMHSz88gx530aQpFj4/d6WnwjJr
WWiZd4dE3wouAgZD7dVIlsuSe+uEqk1586r+rqLlBwgrUeXidJmN5wqwkFXNurOzaeuUcTJg7uF3
kFfr5zCfGKokNDkCc0joKdjDaca3WXg0rAO3fEezy9YcZdLaLIAESR6ChacYtGiVN6Mzhm+TVQDB
3kYrSp6qxqX541TVQko0+yVYOujtHoUAmZSTXPu6tsJ7+ueNBqLsj5ZMe6eG2pTW1haIO8uQRw1H
jwLBetKmgc7XuXSLssLqLWrIQC9JRXFp1pBEr2XaBOlyHNeRrT7sQy5U2WHFZ0eDFV3rPLcsBQnG
UzANyAEL+Q4zMj1fRP26kG5bxHKu4mK2KsCCd9aKm9RUlz0OpnKSVjaYpNMXYx50yYOsJ2Nu8i6p
ipuQKr9Ki3nxxcFjUlAx218G3LIHejbi0mqGST0xncIyOWhFsNw1odsxg0/mXsXXIkdLi43d2Mbt
vZq6qP+Eh52Mn01j9zIg3q2WUhfnMdz/7yb+DyP5v0wk/8NQit3E/odV2v1//uduoh//EcJr3bWK
rCSwUMXg8l+rtOA4mfgiMQTrhBcPE+9/ryZGfzBY37Vk//pHlA//5qYkfzDgD0KmnLusiJHqP1lN
DHe3qr+OTSEPoEBmQ2hfZEPklfw0EY7oBoEts6F9UEts2TBArMO5scNZs6Vwy6vmEtcyavUCKGNI
S3nQ5WVA8VK+pS1HmLPXMigfI6eX4oXZM4G4Y8pM45e74sJz6piN2OPI/p+c7KQ+RUSx4oK3fS1O
CSEmvEYIK6PrcAP7FKZiHLz+49xL3zzlnaLRhRFc0lzXrbD8d75pxpGDiE0VmvahdOKLkunTB3uV
wJw6MdsbiZtFbMjPB/x8PuyH88FfDHsQIGIQEJg81A94HzYVXbO+BQtxDh+F2kNJeQ4r+bptYWqf
w81wDj3JHoUAmHj9EVDX3F0stpmIVMvCEtZtMEe+eCTBJpy559BmelwwQmJJRd19YLdP6+vgHA7l
OTTWLqcJ/I89ZGKCS/hMjHFeqnNQXc4B1hUC+6Q/w+4sCMHeORxjnmnux8a8bUTQMVfZY3asVron
e5UHyk94bSrOAT7eY72/R/1m9Os4q8/JgHNODPJzktCfEwZi5kKvIqic8jSek4qCtQUyDOecbhSl
v1lHktv+rd87zZZC505ul3NuIs55ijrnLM05f5nOuYx3zmvM3OTrsT/nO/k591n6iDwo2lMiXXi+
OAXnTAnzQx6nosDsnj6S5NI+Po7lsRkHu8/WAk/wq2BPvoZitTYohXtOVnh7fqb+zNWsMX8qzxkc
CmGyuXhP7HKB/drRO+d7I87D5Zt+t3gqzxlhtCeHa2zMO8ySh+nYzxa+xXWSkEkOcnVYL4MoAS3v
nG32c/yhsG3r0jvnovk5L03OOSo1EbmFe85dzbKygNOKmJRT7uktcyLW1dpoLZyr+JwBe7na1sPs
bLgS2+csWe8Js9FhdOuds+jknFF75+yaNneHzZkeGZm4smzum9LsI6M9LccjPZ4PzjlbRwS2S4QC
2U8X6zmjx7KW7H48Z/rmnPWjEBrkldqLAaZG1AXeXiLE1Uw3IjhXDnIvIsJzPUGHX73dyoAqIz9X
HM0y6bu6HjAMxipYgBLayxOqDCoVWthULVa5VzAqrrF4NP2uCZPnKkdQyn0CvsJKRX6ug7pzTcQE
cHy2iWX1UZ+rpubPCupcTdXnykpDflsY/O4Vl/yz+toLseRck3kx/dFsPNdq87luY7pDDTfv5VwO
3aU4lENAndKv/vTQVvP0WexFINUo9SD2lvq251GgD6UFFaM6V48B88VXca4pC7HXl2OkzIew6qk6
C2uvQE0Zhg/NuS7VYR4xu94SJt/2uXbFJpw6lnk5NW17rm/Dc60bnOtekjJqYCzvqIcTX1Ebr3uZ
XM0a5VZ1rp6tcyXtJcXaHsiOrAL3GRY7L5lvrgzKOMu/+OeivD8X6FW+NEgizoV7p0bJjT8X9KAN
xF1zLvMbJKL5qbIQfRQ0Mz/355YAbl/e++jcKIi32b0x5/bBtncS/DyiqbCcGwxBDcXk4CGm7jIG
kSyyt3s/Ar5yiPNGPD1BQ6BdUXjse19QytHGAJW+TyH27sac1wzPDMKVJWNpiQZIsKEYODR7XyQ4
t0jac7vEPbdOMBWljYJ/C8+cxzThyo1xee6r3b6mLu9bItVufR06eVntZLu3zEO9q6jBLmJz6zuE
68sbfq4ChLH9KHD7ui+j+oD3KeODphBPa+jjW9f3DyJuwYqO1b2R6MNj66YbymesgPeI4N5MRj3k
uoexN1p+FsbLg2eos+z+OhQoECnxlC0zzv/uUpI2U2+HzkHj0fJIHnftD/ZVWWx08EZZFak3viPG
CT5A/hS1cf1WGP1OAeQ62nyI0C4zMczz18JeL4BKvWPX9yqvSgSwrJfrIieVzfMLkQSfGUe9UIGE
GTpsfpHcVZdLuCkmD+IWu1aaOqN1gdDocxeKt2OER6k1T9e9O/rflLOeDKX67cTyxPXqjdN2mFGI
vPeLak2xsDMZFOwCF9PypecvOKhJCzqccVlkeY2YiQ4TzzveI3N/WQ7eHb06Jx0YiUvbR+ajOOU6
l2Fq4d5DXY1PXiVD+KNGFEfKpeKQu2v8mABdvdw2ERJXSgv9hP0pYpqJYrGD0z12MLGr5ibX3fXE
WDbzlir1R3PfVPKxmcQbazGTlWp41F9nzIaFJeubrQBAE7VElLBfMTDqBDqn9a6eq/lFLjTPHGms
Syxi3+qham/52Zc0psJ8k4sRoSxn0UWM+IcakURZ2P5jSaF8sQSQny5w0LpwWyu6tHzxtpdNQ8eA
yMtkjx5zPd+4fk6bXiaXvS9uc8CxzyOjA+YF0nl0ZjemlPAe16EHRxbr9mPg0i6KZR8/5BbNiy20
DdUWoRpp590Ug9bPREI76RAw33letGq/BxHIOD/uwBUvpcE4xw5vJ5ya7wEPfXXrwrvqrfbQGcqT
1FiCSW/gjkkGVvHb2Dn3owvUivaALy9tU3TPodKAhle7SeXYtilNvOqhLtal4KVqlruuL6ODKvEi
V8mkChQA+gGDbeqPsnwZ1vLVxtz70SFVzVjoGo5VpV7zeVnSRhdfMEv/SB+dlGaX2D5bhd29hHD5
TnkvvK+Rk7+tbbm9bSR1ECve5C8bPTujFzwwK7ztJdIcho0YojfislDeR3bAXAan/tfZAtQZoekg
kT1WSWE9R8h35sPShIfAMNJz6vyNclngXCfD54/IWavujeh1cMcAknGct96OiCagaQZJfREx27ua
/OTKEiE2pMSurm23K2OhD2tGpshICE+xEzUPc1hARveap1xv741bfq9ma3m0LG1eXFrGH4FJo0G5
gltMJ7sKwG3w5VvlXvSdP7ZXdWeztXPkQHXZiB+xB/uc20bZDyDBFnHr0uuK6S5OYg2+9wicVvpu
ovIxF817PBzl7I/j04Dxl33tykEvXuaX+E19h+zpoi4U+aAn2leduykccey6be/6IS7ZnGh0tKDH
EILB4JcFj2VVHTvWnVeJmqnwWnHHJGn2aE/3lQSlr2g0UGq7EjVcGscMbB/r0pv6ZyQq1vohkLLA
OkmjvVPedYhzW4VWQ5aI2V4GaTkuYqNQ2qt4A26Vvv0DiEIMRx8WAY26/pT3Q9FLHJeW/LudlBFE
T6RNfKQRYdhHn23LtC/HYaODGDq0/RY/XC9mT4VPNUDsVNqYdp9ChWhoTMMFPfLdYNWW97Zmh+O9
57nKPrZu6divqipx+/xTF/7/Ve3/UHj+XVV7M+tP1fRDXbv/H/6vrvXxrPkXsfhcvf5Z1u4uyBAn
HEbfdvIvU8R/17X2HzvpPYS3c6bq7Mr4f9e18R/nxVNgx5TIIFb+oZfEvoHwVzkwfI+AHTp7X3mM
WBPcBdd/WSkyIpoZsyFawtwbpntBucI40+ZkGjKbQ7bDPaWDlElii8QflHqo19RSdt+ncz7YTras
RSWzthCd4Q3tcvZxqzK/duF44Bu+5Bjthsk65OC6S8XS0lw6a0aeV+S3swgFxQA9o/aSK61fhqI2
yOxye5cSI7L2DiD51utdiENAWGLnEaxOQWsa8Sw9JPQsGanhgppunmMOSWREeKMpB/GuDXQOIdOi
ECdFfXtFwrJa/8veee1GjrVZ9lUGc88CvQG6BxiSYSWFTEhKKW8IpVKi955PP4vKqi6JylKg5q6B
Bn78PpNB8vCY79t7bVsqKvFC8Ezd3GbEp59XYapSS1Rl9r/qoIZzktyU7XpcagHLeV11bp/lJtyc
zGtWcTKGl+LUHKYmNg9MJMKFbNHk4QYrNbrG+RM+cubSWMlRPXRbgW7vQMUtvAoGy7tXqCvQDGYH
fJ81VIcdegyc3idv0KmOloJy9HTPb39abSRoq4Q4e4Mzfy9oe0Szvb9O9EqvV8wpnluOeUhj2PBU
Fp9grIqDL4y5ZmudKbNYi7ksHdouoPiq04R0Oqp9WwQm0rThcKwE11lgtWzDfaWB9Rw23lVTlUq7
6hUae4pvmNk2UvLibCjLTP2hI2+kmSc18mvGAcZO0H5esVPW2VDxlJH3hfrRk6TkvK6ijmP2MI38
t10Fw7IwlQw9zVA8BzH59WImG+qD5sv9NqEAq9vyWBw0BTS1nmGXSnmMttJoCKLUPflyyTcjpuri
0GadHBbxxOaYJmqrNpJ7G5k3WdQUhsIV4byXgN9ZpNp+0jvXE8vMdyzSUoCxxgjeiO88CSt4I2N8
/HToGQB5U0gNhcqzNAmoeWAxRKbWLfwwXM8Hno0sYlKxqdimPX03ncDIMOcVlYraUfWtcZ7gytC3
CDyKM+SnxnVh5CrWxyK48DKJ1vz85DhJDe67+ejq1496z5xSl64QjCd85mA2qGJhbViikdRm9MSY
/ATXR2cakiSuePGVF9amyZuO4sGOqPQjqmLLg/tArr9T1RGHM6WQY2uF5b9zCUnNcIHV6lTZA5Lu
V73R/Vdr0NCaCla2FaxYPcpBnHCyTisUbEYU5WeBTHxoFmSvemReKL2RH3I+xDUijSJHv9DGrg9D
+cUatei6KKbme0pXq6RqkoE9REejGE4dSN59qgnCy+h7ZCqR2HBIdTS/tlcqyE7Fmr/CSaqA6vaA
ZWzTpjHC1kBIaMd+/Rg/4VPnx6jj+ccQN/Ppl274SBqMrg/IsYviULvJ06p7aEv9Lg5CeTv6SbPT
RD92soo815LDLJqfxsBi0dZXhtCDD+/C5s5jR+/GSTeemXPoqFE2MYRluTvxypc+D34qGXQQCZnZ
4YQo84h4N7FbXRYgh8C4MFVy+43DHZWDqJjWeSvKtAr1co3DBpsCn9JJyuySkPB2bahDOvVaHVfQ
wrhlWYQEpSOSbx9b+C6LkXFIFEMQ/I3FrSl00kFJZYCEYZ2uQf/RvMvzzpmsfE0HflqJsfXipb5w
ro5yytnPlPcD6v4TRJi51LxY+kB0o/ilhGwCtlvm/ppRNqS5HrRuYgKeBx1Wu61fe0cEPawd01hH
Tk0zJOB018ogY7x25XXK5JRG/GD5db/tQl19kMFXsTuUhUPlCfVKMrt0q6PH2g5G0m78TOaIE3jB
n8Cgf7XZ+u9G29QYB/8M28TSEf8uS3r+U7+2UlhMKPgDzhPBNGjYKWfoza/NlCDp2h8mIw33tYHB
V50L+H/upgTzDyZo4GLYnma2IOrR/9pOEefwB5As8GMqnASF6q38b/oEs9Py7yUBUDuaZY0cdyCK
uOJoZ3z86AxtgBpVecpNLbDyhzE4fpUm2IaEYQJjkGJRc2L/BCX8+O5R/W6C/3xhSCSaoWKYpBf7
NnG9+9rTUVexhlTqjZJ5OZDawLInYwpO2OLm7/bD7QF5wFIGRBdX/TypfLw9LeuiNm0pGE2CciEY
5YsnYQ0IhWEf9z9nJfDekMRfpwry0P2X/Dd39rHxMsd/fLzmYoOa11h3hkgUr+uAPWRA9V+q0xGA
sH9lFtWJi32cuH5dTJ0xcXiR2bUv5/dcSL2usbgY+y7RteJWxS80E/A6ezqmYh+sv35tCzLy2wXn
LcRMesXPj5ny4xPt2lqpvMaQrytqbrRD6vPKK5kx450v9LeVOgq7UG73Jamu7QFPWHDKEDiPyMUr
NTSwggYkDYhLS6xarhRjZTW5fM2llPNWlQ+hRSB0iZtp2+ct22mdOonYUbPSA6ot8bqTAc0XyEK+
hWG2E3ZN3TUnpuZP7xwfmkrCHidUjOHQDj4+FdZzE9JMaFwRMOdTWkQEibDWso3CmLbmUJ4aY4v4
WF4DF+SEZsyrpSnTNfx4warTa90sJ/0q06w5oik8VpJwJqVFSZby2DtCI0+3STYMcEYEjG+RY/Q9
OXJIiHd0pypXTPOj3xIx+fX4+DSf8Luw5iqcD2V6mPNU+H4RF+UhRpg4GVe5WK66RNupjfcdRXi5
mnmKm0AXz9uKODd689UJ0NNvnwnsRdqrtF1lU1187FXiGzWkH+PK8Ovz1IherbFT7iR/WPNrh2+G
1V6Sl0JioFapKwig/s6SiKQ2lNxWunE8twbvFPPld+MCFxFTP1Mdx+bFTxJk5le/lHlNRRVfiSZV
MGQqL3Q8Sd4hgO/fPXwiHBkNyjzXyeL8+D8+/D70PLVnFrwxrfbJKuVdVQhr7CC3w0Bgz9TcDTMa
LyMy/evrvn30779JqLDmLzu1rBjQ4BdvveegXHjNJN2o1jE0ck4SnE5TnEJ7Xzt0wjk22a5tbC11
E47bURiie3g88RuWU/3bbwApILOWQNeam+7vR17uV4qKqUO66TAUXRgKFeAfqrxu9QOySsbCq6Gv
h3CrC46fOUXuBDuiFFHpnfgZy+lp+TPmEfFuXUuqcEx8FvEb/1VX19Wz1G6lwAWCjqRkDkQEGVg6
yRMCb0Paq8KJPfTiiMcYm9/Eu6ewGALkQKQUIrl8j5lJ2voyez6X4mVmEHG59e8AsQf4HKjW0m55
yJIrOo/By4lnMM92n4bDux+xGA4thAUTALN00+qpo5WP9Kvs1qzsDiGmOJ8g7coaHTqMJyafNwTe
pwvPKeWwKWVdNZaLE6J+jv6JfINIipalKjqTh7rfoejYTTceDlpN2bI0oEa/iOrBrvrvU37I1P3Y
r/vk1sCGoCrbTjmyx06LPbZsKua+fiHL268f0du+6tMv5aChsHKzjC35xmjT2yqnL3YTV+vB2lAt
utQH1xycvHVpWhq5OxSuF6+yI67x8rl7rXdathI2A/uyZF1km7I9lJItcz7H4+yKa+2+RjccOK1B
4cOx2q18KoFhcfz4NbYAQTPJzPk3oE0/Du0iML1UUDr5hnw8dErjUyWf+x1w5EdDXSWpQ0PM2IYq
P36FPpa22eRfT/3dIKy6zB0ughOznfq7Yfb+9yze9oADGu5my+9BAEywou8YB7O78GO01GvdWFH3
juILWl80XoJhnZZ3EUA4RIBme+l/T5mIkutURGe+ndVcmM3Fb29m8pVc7g1j1VW0v9RNEW70zE0e
YvM68bZ6ZYs36XTis/3d3PX+ThZzlyU2DfoEnmw4fW+srWWsk3TjmU/teK8oV18PvU87OFAKKNpZ
JjlfoNWZI6/fz1AqAkTLQp9+YzWOfq2s022+8bbWhfXd2J9i4GrzX/ZhnC8utrizPi9UA08+U0Hv
Fgr/sNHnhQjkU3Ji8z0cBCvbx8FGjc+6DhErfU0f8f1N2G/zca9El117aCRseHZ8XgYrQje0axH7
zWrAh0QbDgNkYkvH8Bh3Tpnb9YO6Bs8f6xcRXeQiF2ylv62V7dRdBEi2cRKP5/Bi+cPhs567gXAj
Zye4fJ+2Ib+eLzpctoEc+ZZrPrtNVVCzUboZN1aOCMRJoTc9Kw/gZmp57YWbGo+m4YboVWIcZycW
IO3TVzE/cRZh/mVOZlnuDIEOqxa9HF6vv4kUO2occvjmGRikgceisxqjA56MvF9F60HbBtj+f6L/
6k23kewsv+jLdeCtewBncnSPZpOoPg+Ja3qdda7Kt5acT/W9mdvUzrYhFet4Vb2UhSunDxZQR8GZ
0z7xHJu3k3QmFlvBNYkgPYUW/zwXvd0lW0ZlDiijaPNxENdFbRmTz0NOgk09OfHgyk8is+e97ttk
pbfSRemv5QHrmVNQWEZSZlMIGep1pLtivUFk9vVXZfz+sf/9gxYLr9eQgVgPg3Rjjk5YIi8HYAGc
2A0uhcjpkouyuYTf3en7NjqTdBJIXYgP8hGnKcmFEg29CFqAbQAUn0E4HF3cgZdCf+PSDJwAm/eP
+t54LtzxJrjWnmjAG0dGlzft1hAYRiQZpl3dgLV4wKKs3GPA8FEzv7K0UP8mvvnAHsC6tK4wnJbp
usemIuD/wE7qFvs/09z/8QD8Bg3+9NFTS+OEhjKSOsXHl0MzF70g5cMb4Whdas/RT0txtB9EdDdw
TqS1LqyRIY/nhBi90Lr1gT5dcu/pExtxC4SLnT8JkpsemhtlVdynt+VOe60ODDmRfN6H1kTPYAvP
4U127p0BJhCu6/N6l586TSy37m+fMRQsGUwQJCdxPum828jJBnCPweImeLh092nRemTDHoTCraoN
0kcp3vLajBdEMVBfsg1l9K+H1BuubPkY50MeNVH43oAxP/4CABJCqgeBfBP8RMhY36GrCGmH4B7b
eL1NVSbp14m1ZtJE7SU+yLZ5Vt9mN7zQdpcWLsXvROVkc9HckQxpTi5O8K9/4VvD4NMvBKVOAYkD
F6eoj7/QSo2q0DGW3lRrzJKID4Zb1n/tekUgeH3V3Fkn1smTF1zsLKuE8AB9HllZxVHC1l9Q3Bci
nBkXR8Z0gWElY1eXndhXnrzsYixkMbootNnSjXc3PTcYNA/ti3krXUdP3ZN1n5zYPy/P0PPIA2L3
11PVF++d/N4/r+bfz9ZLxTGf0CoEDhDbsP3/GmTvLjbXnN8Nc39q9KDWOLphDxWHndI6/niZ5zX7
Suyo+cPsCR6gMLCfyskqE9cq0Z3mOmQF9m5bY5vLV9a0LbyDiKpIq+7V7EKdg0g5eWmXXnnE53ni
J/92A/P++SymlyASEDiETLUlrNjAHe+yfJtXbo9sbGRdR6eCA+jESJ/3KV+M9CUXLwPNo/sB1/R4
D5I9jljD11l9ZI8peCvlDuhgdvMWJmBrV96f8vt/nFF/f8s0vWVprvuKS7Kh4PeZ2k6pfIPM4skf
996jJa2yH8WZpNpCcxmmJ/bWn0/08xj8+4LKYgzKfpfVVl7KN7q1kk0XcoxmrdPxNuPeEZIgkIap
scnkM4N9Vizqazk/8cjnuePTE3/3CxYDs6vo3CkGt9zdVsCYWpdcG/bpY3z79av9tPeetw8cbkRC
S6lovu2n3n0ANOF6TMaeeOwHzoyVnbT7sVx3iC2LQLZD61/XKRbXW94XkDmjCrkecWyJiaFt1XSb
pHRHMgFFJ0ndJnXl8jqBmcrh+a67JkEZcdSpZtKp2158RL2pal5PxvjRlPYm4BJ8RvVe8h/DzEF3
fOKT/byULW56cXTUonwyvYCrYaI2Q6cc3LxeIzoU0d1CeFFXnX6ZXpi945nkBe/ExyyBW3Ghz7oo
ELgIomikr8fQFXKn0sEKU9KkjO8U8vrr0fBWJPww7Ba/VP04H2oxivMi55cmLWJVxy/OA2U1dZuI
SuEhqHd+flb4G1TkNQizapPxQQydbGvjc6keVFxUngdrLk9dBfoBIfK9uZ/KA26uDrulIDtDwjx6
HkwwNmj8ohDFoTbp0MwSRy9bpx3dRNjms/OKg2ppHNPu59d3uODTM9LnO9QJspjbiLR9FltnoiWR
UEKbPHbZ5ffC6h01dAZ9V4FNVR6VeGdxtJ+uEiBeJ/mYnzbJi0sv9wtmaGHq5tKBujLQOPQ8BKdt
XAslNp+C7MjeqaX7Y8/0890udgxZFvZ/vs/kPBd3IpCzfWetRf0ngplJvFAsYktO7IveAmSWg4jU
Ktw3MmENpC19HEQBNAZdjEbpSBWuKXequIFEFygUZ9Ya5D2yYVHd3iNrIHmbBIcINlCwgdYX9GtZ
tTsoKsMuTTZeO1eBMAhHguMZyKRdFT7TTf9oXYjmzlOfhe/jo89Y9PmrGxfLO+djWHzdTQUextsg
ZLYuTJS2gltLbFjnjWqY2YF5biFDaNRvZrlp/L2JMw7tgnniU3pbEz8/BfhY9IpkAJ+LmS6xonbG
GojHEFlNa1fESp53r7qTTWvDu7RUB8k3owCfTfAD0w2qaj6f6tuwH9An2eatcBPnYAd5ABds8FSs
uOZWqdetuUW1dBtfpHyX9qCtQtNNuk0wnrX1ejBtFFUECAbDnSWsWvW1FfaJ6Cg5HJn1FME9sOUN
paKJh/kt0CnHv+CDNDmjURWOTsx7n3ZyjHcZtc1fT2AxyTYWEVhtxHiv5esGT2+3CYWtvnsqU9OW
hN3XH/ZbpMJXz3sxyQaCOQqZzvOmyLKrng1etZmu+pL9I3xCv3DMwBZeksQuZchSG5lN854zJueq
5+p7BMSByetHfCLk49PGaX4E81SDEU5UcF1//BTAvYohaSLSsVJcpbahd3Eu+frGP29W5mtoIkRY
Ca2Qsay4ZGWcSCkc5qMB8BIpnUVepN38TH74MgE9TjNrJWxM3Jm/9b99fW15/v2fHvq7ay/WC2VQ
rEDFUHQMa1u9N76JL9DHGYJgPL8Bg8K03IxwFGz/kWpPLTn+N4+ayjbmWfu2eAKL/7tF/f2DWFTb
fOgzfTj00hEh0ZQ6+XWqOWLtYqQ51Wr6fCRaPPPFKpJZ0yik1SQd6zHbztlPOV+ji8felM7f3DQc
XNaCeDG2J6aVk1deLCJAlgJx9LhJ4nkpcJVYyxAw93h5VoAN1MJFp681rnHyFDi/yq9e9WIpSeNI
xSvChfXv7X31yBjTnyYTkqEt3AsvAUi70k2QT54qdv12xX7/Wudp5t0WVavTyCSSRzpqyg2wYrVz
/XIjHthAKpcoEV/aYVMovOnpxHBaoHd/LZ70c2m34xijqbuYwTF0N0rXixL9ECcighup67iuvI1m
Ne74HfMM+e23Vf6QGZOtRs+hfxzvpmJfKY9wSWEGXvXIkjx6sbQCvdkw5ujyiLmngthV02FZff0x
/n74//1zF3NN4BVSh25fOuLYglSKdsyod550T/uxLU+VeX+3saDHRDiEiBSCOuTHlzLbSvtCLaRj
hrtQB+yDVlhS6RUgNcB3LyD3XBfB/mTpU5nH96dh+O7Ci9FQCrlZtEC+jh7b9sSehcaDU8ZuIq8A
n4oQRTs37dzpG42QWF43gqOTMRS7WU0l2BaVVSu5NYg26AXxbhzwuqzUBubmWtHPdeO6U49+uI66
HVwHrb2Yho1Xn5iwf7ss/n0Hb42dd+PZzEJJqNOSYaU6DZXpGZNCNXSMHpthOwXsd05mKfz+oaEZ
Ma15PVoKNBJpIn0Mm8QxMHYKeL0qOq8lpJha5qrJDn1k7a+NdlOKTqVuR1R+A2dASXF0HBcVGL97
Lb1IkguKbnLjauHlMF2YMqhFwmrsqtiV/YXBqcmAGCU+hi3pw6speUjUXZXhc9vCcbfj6bzAxVMk
5SqLqJfL1FSkm8A7D+vj15/BIjycz5YGAPp91ED4ABQIGx+H5hhquK8HNgJWcZGztVOx1LSImTFV
p/eVtTOa66i45GtN0zM/3RkRWa60Za81iHUYrNGDFg6EV+ulsRzlVRpXQerGstuyV2MTxubhIAgr
vHJBxrntrNkUiVOuk3E1VOva2PUP8plos/TyQJoEIfr117f31sX98AEsbm+xAAiEeuJo4/bUYYX2
X+XwUDr5k+kIe2vXxfDA4Y5BA72mimxAoJygv5ypGgWptVqtKakV3JvqgOmHEeMhu+5fI8Gt5FXL
Y1I2uQ5OyMFvB0WBe8etNmzV7FjBtkucvt42UEFNRwxc7ZAajhQ5PBq4kZoPN2Stx09pu2rkC0rs
NZBcCNsMttRuFUyzqJVtkJjN96G0i+8cXyt5nRSTrXuOaq4r7VthnYhz+Lw1mp8VeWKqSOSFSBn5
41CopFBCaeOzNVJXI8GyGA8n7LJ+YTdIgtQNGT11e+WX+2neew97vXk58baWs9XiByw2pVUn941e
sv8zo61Z3hUNHC/HkM8g4n99oc+r5OJKy51YoSloothsi96q4Wg5jg+Sfi0bu7Kw23xvedu4OjNC
N8/dOt+euPinKW1x8cXOSyRlbvDmMVnCihodPXEtBsOwF4VNn53X3U4L1hoxId4+rDZSdPCrDeGm
VmZDLsCDe+LXfDpnL37NYgKYKhWqexRIxzQ7a4ytSXeiXalHEnHk6xL5QH1qTza/xU+f5Lthtvgk
UfSoZAFw+wgcs/Fn2e1SE9+m8k1MbzKSOuvrNn3gqbN18YZ69/Xtfj74oHoh5VvRLHjWIIiWY6yW
kyGb1PgI+RiAIEGgMJrScNVY06NnkCYxJZPK4bL9Dp05OIvn41etKZDLDU5DmQZBfay8Q1+lmaOO
46uJF8iWJOGlavTv7PnGjZKOz4G/7qbeuGDFup3qqjqx2fq0u+QmFA6LBGPOobFLXsfcqjeUUIqP
sKTob+F5XQ0sW5uvn9XnSjKHUSTuhJSgsEeBu9jSNZCShcg3gmNp6o9EbE8rJWwQ+OYNLaYYGC5S
5XOLWQ15Gp3Tlqa60p2618/T0tuvQD5KujHmEnNRIBkqiPm+NwZHHUg2aBDo0aUeOVlb6zty0HIT
2ZSlKj3QQCw7W0E4ryP5aJTSXdsTkfb1M5m/hneD18QKg2qKriRgCRkH22InVw5DSXKG5x8HLuKW
YXKEBmvYYuO/9lV1KrldXnwr8+UIoqEAR0cPZ9xSIolPWRNxDnDvnXJOgKe0loBXOGUj38F9ha6l
httGBqhaZOlTGftoGMRcOCNL8CHvWMWLzhDArBblyk/SZxqgfttq27KD0poOquKETCySBoU90LXk
xK532Xeff/zchSA/BeES6ZaL4TOCjUPIolk38kDrYyopH1ZSpq4tL955TXJB1hdsBH9obCDf0PD8
VFj7FT2koowBZuv5/ZhDGgxFeScXpr9RzDM9gHkPIjfCateuOk059X7lzy/4TWZFcO+camRoix1z
TzIIRDxfPGJCPQTgvPpSjdzeDGvis71bIYwFAqAnn647cZRJUGSrrJbFTWT2By0qmrNhoFiIvPR8
DNNx1yqSQ0bgRYiuG/6BGFx53KfTtiDu6Vt1h0Bs+wNAtJnNF03O16N1OdvxCnQEWNiwyTHQDf7x
cUlv9DayQk2sjwScl5so4On7Avm54ZAZKw2DoBNGD4QQtmvwAJgCfYQ0RhqjgoN4SHO0Hfb4nKlG
0VnO4to7RCElOOjD65Amd1415XUjGzmboDFdN10BV1wAYi0PnK6/vpWFO4nwSoJfeSc63x9eTtTM
H29F7AerAwhj3URFlUNq7u9ktpoklR40BhLU7QLCfNiCJaJWqgxaf0hhekA2MeN9IsWrtheAaScg
6QzQ1cidQI8rLPdvP/NfOVcuwucqr/PX5j/mP/aMbRopYdD8n//48J/+u/lb5lDvf/a3/N/0pQqf
n7L/dXxK86cPbmH+3F8OF938Q0J1O88Mb3IjZs+/HC6G9Ac6QYy/MoGXTPa83r8cLhL/E/aBefKf
mxA03/52uEjqH8RjznY1rEiI6elQvD3nv+0X9eI/v3cSLj5+rG/8OhGHC1fCvvp2nH532Kwaq+xU
rTOAwEqyi2QI2nAP9TdOMnHnRc2p3YiymN8BEDFDokCWiSpinrcWuxGZ/IwynfLu1iBHw8OJ0cww
KimgEUQ1mIAMVT7XmNfXYonYNLdUf1OPAhJJSfWDfYSfAzZCSBdbwS6/U0JlROXQPqYmzBObBV29
qaBlffcFJd74+FkQGBmk9ikQSXZj1EVPgEhB3kk55MdAb3qsqWq21/JgjS3RaM2Bpa2c5FUxlOnj
u/Fx9WvNfP+s513uu5X07dY1EdXb7NEWoYN//J4l2Uu9Me2a2xjXrBOaMqkOo/IwgaE/scWdJ7mP
V0IeQYdaUlmIgEwvJkGrwfapNHp6mxlhA7MQAJNRBhIYjzksQPWLHA+8f6o7OH8fny6roa5jAlbZ
KCxDd6Fl5EMWDOkt7mNpLYctkaqNRXNCwXWH9zZ2c5+alw6MCirU86jXw+3Xj/hTwRnHl6STSSbi
JmPDuNwniqI/VqqcprdKmckHH/r3ZjDfYojSQ25wy74S96tCMP11IE7XYlC3O6IgPFecg/XiWpNX
DbjejZ5U8SOs4AoGkRHuulwFxdq9qlVaYHGsqoukGk/Jnpfjw5Kh+luIqRR2Cey0FuPDn1pFSaxQ
OEbiN10mM0nYy/GpobH84OeLaBKOC4JuiXpbfvCdX2MY9mPhqAfpRg9fmrTYMAtshuj+f9aFZtz9
/E/wEWyR/nlhOH/58ZTl2YcVYf4Tv5YERYeLyJv/tQoo2hsZgl0X8yKS43k8/wWNUP+Yjegy2Zb8
Ac5uvMk/oRGKAgwR7SDat9nVRmrov1kCcDN++G7JzWRz8UaLIIYPb9IyrK5qOg4caSzR6A4RIEdd
7P9MLOCbDpj3+EIU2MwaURM/pkY+bgSDMFRmrlj4bpiVbq6SyM9/tlEo9U5XJMld2PR0yhiIqkv0
kXTleUREkd0geJObkiH43Y8hZgM2HmiuxUJ8jtMzztgIpxNMIAqPk812HiA+eGSr4++MvASfgUQc
k2h5/WtSWtpdRgP1Nuqy+NbLOrQSGXDsY2704NbzTi3O07Ttb9OxCQ9C146NG3Whj7lKanRKlokX
uKAMPVcSBhHnhTZWD40CbsphuiIlXNdaHznDZBSOgZXsru2wFrmVkGXDZiraAmURBPCVpQ4jDeM2
yVHNay3VQTgR8aMfFj+TvoqjmeswnxhBBmHAQwDYpSLgG7W0cJXLPoh7dRqVC0MH4q4E0iHRMi1Y
CQQ8ZU7sxePaVFoDjE7boNYN8sYVzIbuJHx+HP6cozTJVrWxQzk9iOK+SLoMSj+kvO9aIrIaZpjS
6RS3EvAoQsgUjkqBmSiO5GdR4/LfwkZVhTJ3fFqHuhNISc+u2YwOda2Jl4oIa4abG0EsJbkVxY7a
sO9zg1ESvY1R99pNWGfjdxPfg7XBGKEOtkdYCGcbK+tXaZIDywZr6F/RJdBjx5AMjwZzXODELA0l
eBza3AMEpdfw9IiGwfPCticXnNxIy20LR+o5ybt4w2nQK9cjQZ+vqWzqP8MAjtl+AmIpOXEm6C88
LyA7VdmKnm2VQdM4xpjuQHUINBusNv1RjTVOL/THY7WtMR5eFJEPK6gKVXC6kU64kANOu7oOa9KZ
7MYLFQ2ugundispUvhJOr1L46ACQkbUX17eEs6XHBEBz4oJhTyUKOUW5rybNfBhAyakbwtHE6lcJ
7X922f+bcstXs+ll+vRxKp3/77+mUs36A1iHzDwizVMnpaG/ptW5kPvnNCrrMGV1DlKSMjMBmG/+
axqVmIrRn1D4lfB7qITf/ptp9M068Pemi2QGAD9EfookcRoiE/OiyBk2hMLRiqRuLpgKwHNdg4BO
SoiouNYwSlddOAnNruvMrrwQsoHqZtwOdAGIjCCjTigqBZA65MnXQvAI8xIFZKORnHcemvQWp/mM
ippjdSQLmyYn7GezbqBECc1M2SQ2J8jOtDiljkDGr3YUsq67F8cy0IgZyCO67JWcqa5qFXBBdLEU
r5tGCB6yadJwBAbmzKGjEjXY4OkL+O1EuyPhliotOYumHK3fUFfDY0ruUsVhFzch6hwD3U5YlpW0
5kCqJ6umkXLO1Xmk7TUyebxNWmqqjLSkmCbantUcezHWnEwtPiE4KVoSxus6DkPl1gLRfzY0cYBB
i4ws/v1AVxfT1GhhFvZLpjqzbskFSWFv2ao3lsLeyD22lHEfKMdO4iadfIxxtElGdaKus2iq82pn
WDA2NIuYWo21mIH2vsWceBLQj0iHV+tZRbbtWsIQbK9P036re4l+HTFBup4mIE+UA+Mg1iLqMD0J
yW6ResPc8hdnV+++gt8cJj7u4wgglqiCEssiIc+cd/mL0SYlhZ8GvWW6KdTbgyTgj8sJYCTjc2j2
Mvl06399PYx4iP0J6aX8utw39p7YJfJUcr2hntZtU4WPnsmSlDZ5/SzJUXWiFPtxMzzfHx/RfD6m
XMblloH1bVHHJjYexEs+txaj8d3To4wcL8Th9/WtMYG8O7b8eSmmEcxenMzUZdWuhg6vw+8yXWEk
O5Fogvw57IvplBDn02WYfqBX889swcksn9/ou6N22Dd5NPmh4WKARccZTFiJfPLev74ZeVFBpZyg
IUqgkUvcAJdjhHy8TtwPKlXgnuax59WdtdIHTRhcye+Vcd8pTVjeEWEiao+JKkjCJjPk8JUNgVys
YPDnpkd3sNJYyxPKAsxCQTwMl0MPbZpogV71HiPImWjI5JzMXOItChkGhpz2HgGtop9tITMLLxaZ
pumF5StCt22HSf+m9mQLraamZQDFTJKU2jIVZKNNbihJd1OjtUSZmf2UPgaSymbJCZDQpGtdiyD6
sqMjtG4N7z859orAHNF0wJ/dKJELaxPWtadeZ0I571d7NNPQOoGTpu6kdX51BucFgDU47VYg1whQ
ZWdqjpdyeJ75/YE2wowXBs3xYx2AopBpo7/OpDTPHYn8rfQgTcyt7lxXzGhU1kC6ztp8SBmJaRqL
K1+UmmjdGWGRoEQmTgVBRyfq4Uoj6CM5eL1Y6Hd4FvDvmUQMaD8q8m6TFXDSotwEZl1nZ2KeeQ+w
MIWathhxCA8DMJLnKRKTay2Oycq061IKm6sJFnh0n1pBVF0rY9l2t6JlFDQOwzgPL6Y4o71TJ1mK
Ntcreri9boT2UFqrtTe222YquhJv4BDF9344qtFNKRNC5jtKFYSHqc0EmXrv0I4/IKNn/JTGLC0M
hrpHhyo1q2DNFbEZkbKCpHAKVe3HGM9Nf8EfezvoCq0jIzCqi58kmMZRh7fONylOCqOloOElzEBD
cFcJwp3QJpZxR6opSYlh2JrJOg8nVM5qBa/srg7aXD12xDMP94Rg+Nmq9s2B3NI0weIhmcLYXSbl
lFH5h0aXeA9szRR9j0+pamxSuaTsO++CEMRt0PSGRKiPoXXykwzOQaAZDwqyfPbNxEAT5UP9oZ1v
WiHZur7SoUqhxyS7RscC2iAWFGxT6GPfBU7ZZWeJ4qFUsKq2HrfkH0Jnh79sbMhgVfRNoeaECRXD
zPhteLnmpu5aU7QbQVCMVcPvjpwqm4JsXVZAh7fgRfPHUWZMulMb977dNlY2uGJP5hzZD77noWpv
cSVG/Viwpe3hiuzNRu38VVIAnVupUPV6muMmISCj55+LGRGbq0HR0JMm3Kq1asz6rZynVgS0GYUK
EnqAaC94GTDAVpCoP6WyQtLYkI1UkEOrGAmX+n/snUeT20iahv/KxJwXHUDCH/awJOjKl6RSSXVB
lBy8S3j8+n3A7t0psjhktM7Th4mJNkpmIs1nXhOGyHNYJe4ZN7pRoVavOlo3bkNRmtdxEwm6pXjv
vkRUU8o1rnOQ8nCLict1VUW2tbMyQvCFPbWzeCepqLVokFSetWed/FYknRvcdw0qtp/CcBBgufVW
7bCPUvO7ujPtkvuoLBIsQf3gk9Ex3yVuGDwuDu8MbHOtjfVsuh0NWabAdidXz/jJk8XH5ZenNuPM
OuphRCp5NygxTtrZgLCxux14N7iBjAlVnQ3uEhRYqqtKF5XIwDXkaYognxNVtafYU5kZm6jPfS24
0J046uwh56MZlFxpmc6FHks/loLgCmly3DtwYR/ilgjQsRLfuJNSryjXl7Zbfh4ypZ92AjXVaKMq
gXhpOCbuTV5UXQMl1lS1TZUPqrMkkx1drLvxQX46/4QcPb1kY6gPIJShabyIFKPmMt+bhyrP/SCM
ZBzi35Ib9+6gZh65cg9FVFMuPL1HDde59j2PwIM4P/QE4UePFdFkycVgh54qu3ytp1MGBrnv4dIW
5ufRdKMPJQ4j/D0R3PmOoq4KpBcRkwzL3flJz6/vm+h9/iEzeZ8kwplbeMeUHtzNa72ZzX2EMdrW
lqcm+GZwHyL75Ku2e+NI37iE+D+KCNgNhAHIX822FnOL9agWHqMRCBna6D2t6kekR7hd06FIVudn
9n4UgsQZ6URIZZKjkBu9/ZzdgFx42eF8VfSdsQrKIN50rnpJ/+DEKALBS0FuMceks2Dq21Gqgrgn
zSJcGMJGxQDdELteqe3v5+dyWNjm/Aj+cFI16FdsTsY7HEWvRT9UaUr5qUpp57mVsTTLVFu7hcsL
4QQDpHUIG/tB/5N7/1NzWeB/X8l8fG1e5UEdc/73/0q+xR+k3WS89DIcetpzj+HPmqap/gFPjAIl
Uhj07/k33ibjiGORjJNNmWQTs0TJXzVNYfwBE2TOL/7yhflbQrhHu5ECOuVtemsmBQLQPvs2wZsr
zDa4RbXSr71alsatZmfxFU31xzeLcSIFezcIJ9ekMmZwgLkx9lnjm0Fa0k0FtArcyhRRV5M2zraq
Rv/vXUyUFfjjZxkrJNqQf3RYsrcHK3ZqpeDmklBlfPWaCu2nECV+utEKcZOqaH8Wmv4tmXJOZd/c
g38OR+eRpQMS5+xFZN5MqjYiv0VOXOKni5ivPybuciD1w+AC5DZN7+jKTFoHPXw935xfztMjc7Y5
3JAr52rO24kWzawRrquMnHbpTVwF7m6w8I8P+nr09CSr5lbduIvNerzwLB89ePs50xokZ7JoqYp9
ffzNnLsR1f8sZWS3wvaz7zGS60qcUkMH/s/5Sb4fSpsBRoCZaFTN++dwklHgY8JbgzgNqA0vC5UY
qnJruTQxwPLOD0VB4N23BMdkwfow6fHa7+TvMvKKuo4oLqW48/QogLTZVQTU4yNuNxZ6OX4uXxwq
xTVVHF2LEErr211qttlLWvnYAZshHI0YP2kc4zr/M32EsIBKnkS/UDnXF0Oe21+GKik8oxzUtY9s
aywcHkyp47kMTTCDQ1bW9ZdxSoNno/O7F0ULo08+CmlIHiRTqy19v2lUT2DS4y9rPxTmKjSGvlg7
AbLoGbqQN6FjRv7SmvzmhiwTALnRVoZE+16ZPps86N/9SaLrh3VZWvN3Qd4sulC4v4YicgF3V/VI
Hb6qAzw6c8u/tmPNXpad69y6sR7gpS7dz00t/F92EbDN27TMf1CwqrRdH9cmiV+TZk/UnCewuiSE
9Krb6Smi2PtpNEfjKZQFQhG5bw3k27aYcOfjTf8aO9r4HT8ILfIy5OU04twsvousXkHWPbYhm41N
mOargISl9UynC03+EBNgkD40AxywugZI3WBOBJZpwh5dxVPttSasVj3fCtWKLr2lXLcuGZWXl834
vbTy4KdqK9Vtl8RVu1FlFX5RzTj6pPYReC1dmtanqdF7ot3YTn/gcUB9npKXeottXHUn4nFaNbYa
ZLhxuvlyAml+T2NQvcpKYbSw5BS0TqR0yPoJcLtk2VuTYsFjafp1N2LKvRwLDe/lTo5ea+rKFuMI
607Ta5SkMjd2f+BLVz9GqhqVGxUjO+Q1UkklFHd27N7wK4CVVk7xZ58+Ct4NZeO7KNyivbuoY9x3
yzJBhwWLOfM60fGlX2tjJ9XlmJfDvag7u151GrpWahSIaRtaRuEFPgx4Bd3yZNv0w/RjzGI8MIZx
amoUUFJa0vgODb9wCSg+p308vtbo/z4rqpwKZJ0nUyy4lcFOD1ppfXHMCm5GJ4sOrofdiWcS73Sp
4waUraOisXZdKZ0NcXP3rXUa/YNUy9qLiqn71TQ1Riy9Vht4jSHwJVqtzi8AmY9rPtxg7uykNiMG
TZhkDu3Gt3dn2U5YPFFb9cYKZW2kFavR2fTuUw7QHGnwFc07MJ0sR2st2vxjWX3v9esaVarKvTPd
myG772NI1votXQ8KNalQ1kOd/nnB/yeO+qcQxAb/Po56yqPm549//I98/faPVRbJ1+Zn/Tas2v/n
f4VVc7uCjAi0F7kiLQkSor/CKu0PMKlihgUBdQWiytPxrx4H8EyUwCE38I65c9r5f2GV+ANTAmCz
BswOIjXQfUfooHNoofcRDxghjW6Jie+IuYclvd1mkzXGoOqAgaK5iWtTCPwT1fT0QsQzb9bDEGSe
HwmyjjgkWehRTojraaSXEnIAQBO5VIpef1HatqCeo0Y3qL0qi6pDIXBqQn0+uMWFyvr7J3rO0/kL
mSjUAu2j4THCzgrfGin2k9KslEzF/kkL4WdKwH5vtsGJCPLEA81QRNAzAxim1NFQepqGQiiD4dHS
XhvZ9Km3UnOZxUWF3C+gxQ7B70Ujoq/nhz3xGVlfQnY+Iv9nj9F6E+/ITiomfjTMEGPyRea7yrr0
/e5CPHeUUbNB7Tn8n6NW/CWADx/eSQlobmQNMOJVlTC6GYc0f1EYd6Fh0nAD3Kb9fn5Wx7WEeUDO
C0qp5NNzp+IogHRLLNzb3qbdhssEIN8m2ykxdtKQ7AQKKHDS/HZpYTW8boFc/qLY/BJRe0UvUCuf
LvwW/f0e5rfQ2UZAmhTpeBPV0Qi6PAyQVOu6cgEC0BuH6N7PLJ6lzl/qE67Z+EvemvxmDJW1RRsV
1ksQY0KuqG21PP9zTmzpg19zVAJwslqNXEPRPVMRc128flX9QL1Si1q9pEB8Ym+B/gK+hBILfZu5
3fr2imiw+e6DQc6npyaAr5KPaVmLC/JTJ+fDqpArcCW+A/mm9qi1eS740pzUK0At+nKw43BL+++S
uMyloY42leE3zmBBbfVUOwQnMCtx22152wT136zT/Ll96dpAv+O0AI48XDkKrpNRcyN5Ja3WVWGr
1XWvo+f1d7cCqSSng3sNdXMA14ejUJhvjNJGdc70dXWXZ9MIKSzNdhic1b8xFOJgQB3nfBxJjcOh
KMeOlJrt0sPyyv8UVSHeX04mPiPKLy8o8rzfdfBC2HEz9ps46PiuadoirqSrIgDXU0MOCyTJQPAN
q/NrN6fahw8Tn0YHpLV/GngbDic0Ynyj6oVWerze2k+r1qFJThZy2latbnphad9i0fnb84O+34CH
g843zZvLuh3sKrN9sE+WrzmfHdpcSytWaYppOKRcuLLfL+P8qWgosw3Jneao5u1YRYVdpCktyMc9
8XwzuJTIkai+EK2+fxgAdEHAZPcBANb2MNI3MwKfntIPM2sv1yhf6HVpb4loEWPrM5ZRU8wL3KET
n41q4VxhRfd4RoIczspM4ScAPsA6o64Esf1UoKRjD/jhuPl4VcVWu3LhAVx42098t5nEyyKCOdHF
nj3+ZpZ2EQa6myGVm8D2WVq5zK5S6AOeE2uXCEMnFnQGD7IxUddXAZsfTjAMK1ybBiR0JrXt7gtT
th/ViSZdAYh5bYQuOfn5PXniqeWVNYk0iVuQLjlm6dRBUg+iiqSXqIgMiLrJCx65ClRE2lNC8aNK
4IdXSPO1tA2UmmTTNo+u1lePkVs53YWL5n0YRXDLGnOlUeg2jnHHUZMndpY20jPnFt1iaFItX2lN
kyArkwfVhxonT3sxwm8hOYq1+FJn/8QG416eXVIA5aO1cXQvIAYmtD5k/NZt/LWeo4KY9iTwWLi/
QkcJd1XbNxfm/G570aUghIDmgpDq7F5z+M3plWsTqWXrCS2PV3UXAScqHIUkPP/5dz82Q1EMnFkK
Mzdrdi97eyuUjR44Vk2brMdKPfUyW/gbR/XdnbQaXfX6qjc2Y+HHKzxWDBuVIljk4PjbKzvtq8g7
/2tOzBt5ZdQWnLmS/M5hAb9gUASCVnmTSXNh41rxwUw1zDvNIr7wqLw7VqjT0jkRJE7zNt8n3W9O
8JTTV1XMrEFDsQhXMoopHCnB8IRU17AOxtb5cn5q725fxhOzPvnsY0PT6+gYW0oX29LnxpCh635P
hom+Bq7eu/OjHPcgATPNZNC5ugsbAuXMo88Zd2hwTWbPtMrEv9ZqN4kWRQIPtFEioV3RW5WrZGjr
RTzo4Roz43hlJ0N01ZdO84CLZYDyYRsYN5PTRKvzv+3UCpjGjLSiNQDM6uitszDjVKycirqp6ipg
FX1YT0UaXoge5wkePOMWoD9Qg/shQPbMW+zNd41aXwlSc6JYkkQl8rHdlNxEUxL4Xlm1YqNDTbut
uVI9UfjK1oxc96IQ/TyRdz9Bn1vBFJ3FO5pCUGmJVmAL7gVhIla0vPCA83NUmAphXreYHOOSUcYx
mq5++IU96j7UPVp4TlLjJwZhZFtS2rvwLJ9cFpMGtWvPsfvxjQKiR9gJHFOv8YuoXBmlSq4w9mpj
L3nMEmTAVX/Zd2p6hSXutO0HE3r8+e//7iLly1CvBj9p4oQIV/nwy8jUAapkz1sz1qr7ktVYWMmY
7ABSuL8mxRnYo5N24ZgfuQLM6D4KlirFMyCiIBKOWx5Wqw5KUKQ99Bj92ZB3edFQB1O8XMH8UEez
2bB2uhUsB0S04mkN5nyn2z86oBQ1Wp5m0CyzYLogDPV+JWaWMzUWcBHIBB+3JEJXG0JVWqNnSr29
Sfpa3NWlVuGgQgihxJO8t0e7/HZ++d9feGxJ9FWJJWiAo1l7uPxjlfctEGwVMRQ7vh5/JTjAD2W2
4mnLLkQQJ+bHk4m3Eu8mTZdjbdysN/LWmZLJo0ItHymOtysdL72PSSrNrZ9Gzs0Evu1C8+X9DufZ
mHlRlDxmLep5/m8OvmaE2Pk5LGqEM6yHl118FVBp36ZjCdAGW4Zo66vgFRap2453jSin3fkFfv94
MS7uI6AJSVzftbiCEjxbk0QTaIfWX4JPCq5h4Ndfe5mKC0O9v0p1IkIL5DPzBNtwFPSWcTnHY9Po
Danp/8hyP/qct/rX8/N5PwjKGVR3OH4mvmtzd/jtgpb+iOF9o47eOGnaT6UI9e9RTnPj/Cjvt+Ws
zzGLdMzgSQK8w1H6EdySFsajp7Uy3Vk1skILRYu4rmvYDGE0us7ffofmx1FVZ1UBA1jD8YjONOKr
h6kyhu/qVpcVzqB9Z1647U6tHnfOnGnR+iaePpqXGkjMflPOuJIA0IzNCt29LFmfX72ToxAaw6mn
GgXA5XCUqe2ifsBzyUs1wpasjq3rFu/rC9vtxDfC+ZYGPgoT1GOORXUSUFwU1uhr9mIQu6KorF2m
+NUHwwhDT6Plf2Ht3p8kMCCUoikugrQXxyJJQ4KNSmQyXuZECk4ICrJ20khzG7zXcOllPDU5uFb2
/JWItI9b8HXaUHCulRboXBMiuAj3XQ1+qWr8wO7JL+z2E9+LlIokYr6k5mfp8HtpAZyqanQar8JA
nXQJCFwTVu32/K44sX7zWdJglxu0GdSjWLNoO6qTionzpRH8zPBeJc7RvzbcRpvfGYj8jNSU2uzx
JsfIRepaqeNa3lb5h6rHyBWc8HTjT+2Fy+jUlLSZVjw/4fj8HN14ipN1EQI3LSQxrXzQC1NfKbZS
fhxKVGTOT+pI6GEOGeay9r/GEocfaTJCETg2GXdV2sh2gkZEtM2eomHJ/ec/6pioWWsMwrV62bly
yomgyqEBuWcT8+kjkPOl7esZbCOzANU69gLaktra0XUzNNOHIZdD/qlX8vKnBLwq0HXORtuDN53Y
3vmpHJF2/5wK4DeOEIQxUALHyybDOOyUovMAPqurMNTrWwAgzZcxhwpouhkKsL6voJ5hTMqNqCN/
O9pG+RvbcV5QpDBnoQN7jpffvMztSD47CuyZC0OrNgFO0CRdVruhemReGOrEYZ7DPAIdaEFEVkc7
f2zKAjhP33lVWiW3ua6DPBgDpbyRoNhRtdarSzC/kyPSUaAzC1DnHZXBzNlNXdJgEELVZBdBPNxK
N0A1Pmh97VZPyvDh/Dc9cYUYxCm0d4iRaNcdXyFT7fDBR1CmLnJOjjsW4PWtS6rvJ6YFQIgG0ixu
QP9x/udvvlmTwsLpetCLVVyqXtwjDV4lsdxOaiTvlRoj5fOzOrVTufRB/lFdhZFzHNJksYgtge0E
MgV9t0DZF8naQOTrDmfiT2OVKq+ZDpbBwwSuf4yk635zWmKgC2d/b55ymLuRPc4lel4Dqk57U583
81Y7O6mlHAZvNFrk0nQjbG/wAAjv9dzprkcRCqQ5CnDP8aAue2UyoHIJedvMSI9As6udYwTZbZAP
JiXdBuErB8el80t14iqcO0+A8AicMKM83uNkKmpSKJgKOWOkLkCyD1s367WHPO/77+fHOrXZ2Nyc
3pkdBWLscBu4faCoapYBXQ+lvwqLsloA0gjWvzEK5xavEZT76CsejtIrrjOJEoA8vTp/m9ZxcVW6
XXhhi81/yrtPC+aFkI9mOar3h6NEkI77UneRvhrH/CFVgYMtacqTiMd2P2ws2WUfEERCDp4+inuh
LPE+JWJfzSjk+XBixnp0nobINIa0YCGpT0y7sYyymzSQ8TKYfH/Tp5BlWq00vp1f15M7xaZnOvsx
WQCED2dcucLsCrcY4HElz7JFtVFVq34RuFO2Oj/SyX3yZqSj6dUUJ2O1YKS8w54kH+P0NpzS/kIR
4/R8ABHScYb3efyaZcLIKfNK5mPCUpJBiytO1KACatup+uU3ZoR1KUWLvZbC0W6JE7+FqcR9lPSJ
th4LlQFrtbwwo1PrNlc8qVLMhfbj4LOyB+56sx48o+/blTaG7SIph0sQyHn1j3f+21GOzleiqXCM
9JJ1Iw372BZm5w0+5I1ydO1dGWjZJdOD9y0EuiP6XGFl40G7O25a9JoxqnGA+nQ+4n4WGE4XY5ZX
91ddkDnPvXS1q0F35JehVNMndDCUG79po2sjGx3rwrE//VtscLycA5qIs9TC26esQ1HEVYwaqyih
oWKpDNEqU8PnASoppqz5r06PvLyNgquowdjAGqJgjanshZTm5Iem1oNREMGyfexPGrd+qA7T0Huw
isqt2Wnw3qo6u5ConeCyEvDTwoQQgDsYqJPDucIDcgq7YMlrifDnlAXJY0L8ecdbWTue8K3mKqoD
exWPSf4NwYFs6eM2/EVQkXsdOyo6F97TUyf27e85ij+NMkG0YYDy4fjOtGglC0A7okSt2rpUSDi1
wnvzUyrsEAmOyxVJQlhBJwO+xag3i943RlSWk+DCRXfqEeFRmEuKZIzoNB0usGx7pzP7sPdiYu52
EU1ZYiz6uXX0aKhJlnudm5Y36lhTaNL9uEh+Yx/RpoEcS75Khnd0lGm5Bpi/mb0HNCu7qrpYLssk
kx/OX36nPhtXLCQ9Ei7wZe7RLBOnzE0fwoXb5tqO8o3UFmjrOA/jNGTdhSU9ORi4N1J+3YSlczSl
roth6tGz8CZqduvJKdRlEdpiFzriopz4qU1igf4ixuMv1DkOJyaqMGkbh4KMRLXoNRVmEHngbpVP
I6zAa60YMCgc4q6+i4o8/G4m7oDMRQdmZzc1mvLcIytHg8RX6DdHWZilF77uqSiBvTIDHZB3Ah93
+PPQCVSHpFN7Ci2qvs2C2Vmsb7DWdpxsaxUmFhdGZn46/7FPvQ5zvIuQN/Ro57jBiYpHJJKMu3os
0mgVhfVDqxTxsrXMr8iIfD4/2KkPMKtW0R0h2jeOedKiaK1BHbkG6GOLK71ymoUam+2FZ/XUlFhA
LkLB/5LOH67jmIc97nZkL3kRNs+ZMBGSKRpkAIOwuho0tfudWcHBgk7H/c42Phyv0xLTziK+mz5Y
q6DJs4ep6eTH80t36uqxLfxEaJ5AqdtLX79JTSKUz0g6aJNUjQqKOdYyBfpEktLKkM2LrxjuKvb1
euGqvfY76wmaw8Vngn7xcZGWRmUXF2ClPD1QAoqyMryqSuD+q8xK8G7J1Cx5Oj/Zk/uEZqZFfRbE
2TFtvypE26F4O3h977q48ySGp3RRvD4/yqmrhxmBKESiCaX/o+cSjKtw+kgbPN/PtDu9HtwrWlLN
Tm2S4cLRPvX1ZpctLjrqZQBtD7dIKg1LMbVkRBdU7+8QUDKeEGzLt4MMlFXGd98FUH6/5MLXf2Mp
qT+jNwhkEQLffFje7JtStWuq1KgEZPoQfY6KUl9mGdzP80t56oNR3KE4R56IoOXRkZvS2Iq6VOdm
reGR4BiIB3ovCvd3HkAEreZO5oy9dOff8XY2RDO5BZfZm9xBW7koC22ssay835nNv0Y5OtBBUFip
HjCKamHB66hZutImV/5GUkiLmOAfvBSf5ujLVAH7XhoUG0zD729bSMzhqkcCZiFVV1qQcTLF89W0
vwCZOllrmSXoGHqmFRzvxTJvgkbVyAf61lCxVcor+8FvxvqJO9/a+t3Q7WoAt5upiLv73g3Jlqfq
5fwKnwzLXSJKylgUzqhnHX5IAzmmQhs4e/lURQSk2bDrLLV8jWt8gscpN36oYtK/5sKtcQ6rG3gk
cWM+BCk+rud/yqmt+/aXHL26cW5ZZRJOJGFW2V5reSjWsSurCx/7xCgg9HnyqNvQTTmO3MyyQVvD
LMiGpg5RrC7QJ0TQ0lK78HVPjEOKQbJDPEW6c9xmLzNNlFndaJ4Z1tnNEBfdRtJQu7BmcwR4lFLS
Uhe0IQkaaETOv+LNMQz7wjRg1mkeQi4E9k1o3reJHa5RchpwBcjFsvVHeVXZSBQluq5c+mYnIqWD
8Y8OaK7mlTSRVfMMR5E8Ddb4HcWOfINSWE/LN8BrTIBu2ZzfKSfeC0BJFHmhEMwAraNRZSjDJAwC
zXO1Vn3IyFtXdi7Hj3av/PqNkahBEuHTdGPDHK6v42pTkDoTAKzaGa8raHGrKamUj6oOg+z8UCc2
DLgkmPFz69wBI3o4VNTHZe9HjkbJM8Hw1Lb6pSjCSx4F8112vGFItPdk9Rlme3TIHGn6EukZDW6k
DW7MterwWa1lOm3UFklCSqZYzV6Y2Qk0FDHZm0GP8hgrqVGBdSP8O7Ky+5VALbzvDNGspsj1OxSq
jXyjt322MhS7hpXhDNrG9S3js4iUa8dvVkXk4DBnBPX331hy6usAGimuQ/c5XPJWRx0PuSCB7u1Y
XY/ZmHoURpq/f+PMUkQzeJJ0gZT4cJQ67W1aSkLDmWnGbiZpgP08Ml3n50Lq+e7TkqnsKd8z9oGk
+HAc1W57V6kpgOfKZPdbe5yqLxPmMIY2fdVH1A5TRyYbcy/4kQ9V+KnYy4DUWugC5279/C5Qcq1b
NoUPsxBjrcb81EZSCe656PLboZ3QO2xlB0WwqwJHvaqQyWkWozM41i7QZ3mSaC9VYgWoF62LWcHE
R8gGz2rpFyYqLSO8Qj8cxu00tSgAjXBCg5tsL4bCb0AYpd+LpCBgMyabzAca59ncIXIZ7UVV1L3A
iiaCGrDSLLuCiH/trrQ+RY4FCXikWdxZpWU0y+mpL6aYGms+Mf6Ayk68QMu4D1bOXuQl2Qu+RHBl
0C8MEwx0tb0ojOBbEW3sxWLgW2aI8c8aMnIvJ5ObepSv673MTFjGpr2SHaipRS1qpGhSbUxCemuz
RE2zl6vp+tjexHsRG+dPQZu9uE1S0Hi8rvU6DTyAWEGwREvTwjEKnpJnDE0P4Wsvl4Mhwux6GwlR
fZ7pRNomjvEa67XEElz49fQozH6EppsOk74gaVVQu2qjWa+O/g4c4UhEz4IKFAQvHUG8olLKL6ZZ
I5wn0G8r90pu/V7VLZ0F3nLqWQmchVn3TemIyhaoReOsbPimtoj3KnHgG1CMM/fqcaloA3sRdXX9
oTYjA7VLJ6ExETQgBTZpayXxMkOW9Ca2bOkiJzeJYVNHg/osggytvMZEUw3tOdzW3VCE1Y5qYKwv
7UbUmHQNYVrdVNDExBoxNJl5vt5W167ug5lMYAqH1ERsShSa39nVtnPUsr0Xdq589suu+wJ/ukUN
s9fS9tppc+vbyOZ9tZy8v8croLx2sikDV6D2YkHWhndw0sX9J9XIcFSLDdkje+fA2gE3pTVIeRYN
6sbjkA2Y/zqBc6c2GKNv+8gNhq+t4zTmIh6FPi36pkHfCKPmLMYPUtV/DWh/4nio6siBKFL5VUTU
4RbQpeJ+3Vf4G6/UPB0/cCWn7mrKp+zZzPIUJdGAChrM1yF8iePSQYI7yn4WtYweem3o4ns/sI3n
JKoQAk3BmmEHHoah6jmGjkN84WSgrzO30SsUl+q03mX2WGMrbI7Rc96pEke0uPeLh0FMSuI5LW29
5eRG8gcaMQXiU2melwvfLruXJgr7cls1Toa9XhyYzyGWY91GE5YvlvQG9fskHFyT7vUQrkMwUsqq
Sd2pXoREJVwTOQqxKyNxS3VlSzvFBFCZ3PskSDHhVXx+SATdDMMJPlqKaeKo/ZCkbXc5urjfAqkq
ylL0ZhQtTCcxniMYGgEaR+XUswXiKPEGwEVyBf5Nc3aukkByj1yHsDF3FXx763qKHgTHOlhWAVij
ZedDH1k6/pArkNjTfOcakWEsojLXtZWUbYk3gSWaEIEYBH8WIoghU7eKABUwhFELt1hF/wvXBrOL
by2h9Mg+TtK1ELAKZcvv75Bcq2o9xBk+tvIvoldhCbddVsSb0ZWcTqGGTgaUv/OTreytVmKEGbW8
Ojn3A7AGvwGsh47h4zA4yEuGfSXWVTrJDPSC1WuLKUyiHjXCGhtVH1z1yN1DeQfiuaY8amaR9JvB
kiPCb5VvTVdZV+cYEmRV74Ljbs0aEwbkLxVfq78BfcwH5VFFCcmaFo2qR0r6hFW6A/0+HXxRh8v/
yiu4k4gqG15XR/kdBVH3o8mt9MkU6PR6HaoKKyuy0qu4wgEh0PA/F7Djl7KyxdMYajH/GOGFJ9vP
S3ZUWiiX9CyOLJd48PZKfMB7UXpCefS4EBwAWO3Q+TTQmA0+slwZqDV/XCRSTT1kPQk/c0wadT/5
wQOVLNt4NnUAZI3jM5dN2dZP+2f4P/zrf4JceROReMjW/ONn3kTNePea/fzvfz7/rJt/LF7z5IB0
Pf83f2lym3+YAGEcqv8o0/ypWPMn6Vo3/qDfDAhr5lkA5poDpP/T5xZ/IFmPhgf62RQqsVf6f9K1
rv0xAy8op5C0770d/g7pGujSYfSEuSUZFGBOgMbUYAGwHkZPVtLpZRhBm9Hc5Krzjc+NbrUPZQRx
uKV/sbUqrp2ut7WFWaTTtTMND6hrF+s8U200vQ1bEmAEyLyq1k2ron+mon+/cBN9eigsY0AbLa7Q
ghiEsaEH7ekgOq+paKvrKLMaJAUrf1E39MQEPUKvTJJi1ebww1xLsRfgQ67lmDYeUmqFudbDRrnr
J/uzgjbFinqcgkmKFf/yEYe4F42WPyfKqD0UrY6pzGTJBxyL1CsSiuzG7BqSiyIf8VnhugqftSys
X6APht0d2hSIwKGbcusPxcqmRxW73c8KVRgUqu0PAdexF2kTBwmnRCvrMshkI9Z+8kVEX0QboXZv
34Sm3Ik025hjvTPCXfLqawJLnuHBLPJX36peKDN8kzK/orK4Sm0XF7byprCHNWqgD3ZgPSCc/ZDl
SrPAhWfb+9qnYYSua5Uby1/19kPuxB9DWX7EwZ6LNLfvCCZWQaQhxqCt6LZdJ+nw0DtfYjRAdTRN
eFk3zuDeWPVw0/UV9JoWc9xCealQm+T2zB6bOvjojlIubDN+aQaoLk32bDnTTZjY10iyfE2K6bmv
U2w8Gyg49RNgsRVaeGu9zB/HQK4hFoTLPCAWsouvNXbHA1RjU/Hvuw4TrwxYV69+1dOboPqJMAYK
svFNUhUfkPAtFmUWXNuFux6yJlo6gbjGVoBfEjm3oZb9qlAcW3CzWop7V0q5rWrnXlSMCLV0ssd4
GzgxsoPmEqkQr4nv3Qg5De2+DcxVJf1XEvEf+KJ6SvOoiPg+DpPVOF3TSF8G2tYUDy0KlIpcT9PX
Dv9ppCBDbSJMhxrSjcrHTBWvZSG2iX5vIEm0BBW/cd10g8UcdrN280VJlbVUpnUdFE+m/6nQN4aR
fpCaD3Vl2LQi3vB+x2H0ECnBTnGNjRQxlUJxpzfmHXL4dyJ31lXxeaqf/bzFdEu+TDaA48zc0rBc
FYF1O3YTxkHGSySDh9BHRFFN70dEFZFOZqQKgYIKoZFAT3dK8lJ32hWBxNYsCf3UcTmM7E7Nosbj
bCohbinlB3fkloithC+meGUHXU+yXmud+jURyMl80EK+U7XNfb9aZF3/iyfxUU36j3mn8+qHmwDh
Z3XQd3b+BSlUYkfLvKbwsXLK5kbv3Svyk6eoNb26KeFK39ZwEp2kXUvtg9t2z1psr43+1tFvW/Na
WG656O1x447DTRsm19KCdxpfqUG61mdOAI+4nesbETWrug5e3DSdqBD6jyMC8vZ8+ELH/aR126r9
YFQ/M6QU9HgtM83LzXg9NN3SROCgd3aWrNaOWt/oRby2Sve2oJq/IPoo8mUfD4siwvcLuRlZIKCZ
JnAxsntTkV9S29yOwn8ipF7VZXmjJBnCoIr7iAbptWI9dkHFMohN4QY7QVrVT5s8k6sx77a1Wa/M
8GU0zIe6qaHfIHLSD+pnv+ruyJOfgQd815w4WJZRT9Ari0XXrIbq1rSKiDkHm6YusZkpt0ZwFSZr
o1M+1w2eskIE1B6xV5eG+6S66oPuymWK0OkC76l8KcENLCwtXQ/at9EZCYQmL3Dt9SQ3FduXKB+K
VfdZqCRcUvq/Qn9aItGHHUGRXCO9j6lWbC/KwL8u8/xHCTmKC93Plv/L3nn1No6me/6rNOZmb5YF
5gCcXeCQypIlxyqXbwiHMnPO/PT7o6u625Y91tRc7QAH03BNlSW9IvmGJ/yDibUZwvuIz7cL3e+u
9NjsZrEptXOKyYET5bH1zUzzip0/v7Ncv9wheZ+flXVcYAgtbsnYDxTedsXgkQVhF7XFasc8NC6r
lfacv1SD8MmHU4oA9k63ungS4Q63CDtdaHqg2ZkkMTmMVcJbMUeFlFxL8vcoHa9qLb5vsnZfIXGx
LRAKQRw8FVdaJLW7OpchxA5qslc5eS61pJLPu0GR9rJ4C4tQq9x4hmbkrAtFxwtufE8PgPp7MXO3
kJZmYCwq66yzgvs4JnmL8mREaRTFdK9aucZwUSdVvgyH7EbAvi+K82VM63KbLoXI1A4h5J26R+zc
oBBgV6WrAXnotlYsWivY3QgJFtm88IJv7PmxkwxXsos+qx4sYzHbyqF5W/jtTaa6OCOUxk0ZFC6a
4KMTGbRtmqLZJel5kCByIQeu6sB/wec06TetnD11bfuIw8u1X7bbNMR33vUivCfFgypUvg0b4TbX
c/c+Lw2EkJBjrQNWR79JsQ2POrvy/NTJUOB2fHKBWWyBlqlTFkjXlOC2SKdEPN7Jv/U5uPRvot7X
a0EJvbUp9WfheG/I/m038CqE3MtwmeDxSOI0ztJQeBKhoCWtZQfCuLTSoptFnjJQARk9W9LifZoP
BB4FhpVok7TteCs2yrMwFKU9ShYI5hD+oKZ4LrgYMo2mV3eUgHZR7F5Lo3sXde6Flfv7NrVuAYve
d5Z8DvRuoaj1k9+vC/nSy3CE8C1hV3MoXWM+lwKvF/EO1lpx0/mkY3ImBssuQ/vLz/Vkhy8FOX/U
ZDOh7xS27/gKtc6eI78InDau9mU7Fku10ooFVhmjExObO7IVu4sslpqzGlm3eT/UX1McpmatGqPY
HPqKDZjD2wV+dIZFYMLG7FGQwHJwJqhF+0MVamNh0nqb9Q19FyR4TQTwg3pj1P5TqiN/bWFhDIV2
kioLoqn12q5R9Ip2fqVH+0QfxGWgSvWCaguq2lVtYuiMjHZTruSkxIJV4i6bBtESlie2jmc1+jjV
stPTZYzuNdjw27z/XgTqztNywUks91wxusRRkPEgvNDYp8xrRH8PVVyue7YRRexWZQWEqK9LMKri
3oseUMnU7cr3mrmsDXuzK/BjNSO7E7J4MmK5iFB+nSt5ck0uuRnIzkzfLZ0WYe1FrqRXRe/vxhT3
31iocQYNy3yDUYq5RdYasbYaneN9blb9GV3g+Nwsp92ziEh2w9pSF5k0pBcJxTDo8Jtc1C5MbzDX
nZ/fopDsLZRgVYmhcDlSrrzBPWwYbcXKQ5EzrQM2q3oufp888a6okyXKYtXSL5RvaW4Yc8yOn/93
kuFvJ7QKAHzFuBLaej2ISAObAgWQQmjWhaAzrcFc9/lwJpfyQ1AlM7mVnxoCTTV3HTn4lf/9T7r1
D0oRn6Vb338kP954dry8/pe+Fe51MMXopwPlweBwSqh+plqq9AWoMuVhOAikXC9GHb9SrelFv/Ss
JBnDJJMFC5lkktGXfyezwpzzbWYFUWRSZphw+WR9IJiPelQ5QkFaoEW6nVmCLyyVkPj9fIxUnxPH
qy2vteMYRWYKCEUlBDvAQIm2BMgxHoyRmtFaN4YI7x9VFoqlrODUYwfhWEP/lxOK6gZuR2h8t6CI
C98bvlH4M76bWTQGjuBG2TcTs1lqHx28+txGfF8wOqehomfe1a2SjaPtlqbaohte0n/1ZlY0DHyI
j5b8jaR7GV7eceEruRNgDCI8R3GjJqWjtr6EBINIWSiiYIZFDZxumN3ISYke1iROp6CwvTPdsFEW
RZX6u1pshO4s7oLUxwtYlLuFEQ9hMmU5ZnWuiYGurqmF+kpqD2OJYH4+IPp4b9YiGEjT1xWvtDGa
M/25ZAgRIoFGpFGCg1Luy8uwQ0tk5zd17VIXghoA3a1rtHuq7qZ4TaChgZKPSmVUWhtndiH1t2EZ
ZsnXVDGL9m7oq768KaOux1W07BP8lhDmTqa6bCSHMwunWCXB8EdXhv0YF7J/YY2uddcDSM/X5Iqt
f9ajrKTHdgeaLSw5VYTB1aDvw1WQnfCnyrdnvmh+wyVDANz1yHwWJfnsJA2edVTQUD4M89JLSMZQ
j2Bvcg0jGxG5lEcUh9pnMaB/4M+xLGhkdUYV1/dvhA61JxrkoV9b7cxTErg/dqvVvVLv4oKuS0uu
W7jRo9zGbU9mEKZyYCd1rSarUDfL4LloVEG+Yu9Ll2NglL6jCVZ044p5fQ+lBENYPxbTmZXWRCOi
G8bbIm7ycI2AfJmcGeCbOIZSQ7uFbl8qKyDder5Ju0TyVpUvD66TYQrtjI0VX3Qu0oG1ahUXedOg
zKj7xN521enSBYdPva7ltpsXZtLcyHln3dZikj+EeniQy9z4JnohqpZ6pKgXmVImjzJl6MJRlUZF
E0RsylulCGCE9KEa3+Zijwm4B7c+bXPrO/0t2noexfGZlpNdOoVmYbmXNemiwwdPyduRfk4Wb4cg
phKhDlp912l9fhH7nXonq2XYO7KPQo09oXNnUjwqC7MzJfo5nI1JJwfbKBWFBXmho6R5uqbDAx2i
KgLb7AmiWc3P5I7ZvG5lUqNRvG7jupqbjazv9DrkI1S5vPTM9LJ96UzEav+c5WG5xelXniOvio2j
rkZzNaQtc1UlFa4RVq9hfiDKRY4fVhQm+jxOI1EnlY4V34lqN4w2hRZQXggCyVJmZtnV5qK13Cra
x6LUh3NFz/3klnkQdk+T8oflJBX+K/u2TeICYLsn6N+9sBp4vENvBE6TxRqRmT+6KUgJhN32I27r
oyPg0mocLCIXfS7XHSWebIz854haOBbarp5ftnprnfd9UD6YUlQbto8Hhu+YfS3XfFKQ3VgCbMRl
KNNycRJ84phMVpKm81JsJXEuR/WYzzK8JGT0CWq/drJQIukVPVG+7aS2RIVFUggU5S5XcX4vw8hY
+GoWpPdJ5UflJlK7LFwJ+ehJ81g33GSRjMjmZHZvdX77TdELsyezbTPZURov9HdFPmE/3b6sxtou
3UKPfxhdKofnal7k+aJWsrIUV2NRDuMVAQGWXVZRyPG2TOuEu1NRxvNspW3ppbw64c5/dqlfe3se
NzjB5tPMsNAJQSAFoaGj3rUP6xWAX+PaZYitkpMacB1meV7Wv9kWfhkHEjnoKcCE6DS9LQVq9FhG
Q8ETakyk4iH3u+FBKv1TgjpTc/l1J34ahYo5sRZwaV0+NlEeEROKdZqRdt9aygp2fkBiFKeXhLK9
XeRRdTa4LIrPb+E7zNE0KtQXHXAYwkLvhEniLrVMnpBrywngkHrywgI36NVz1RjDeaOGwZImtoDB
X2EVcxGUWmzn4Ei/fv49pmrq8cXT8gZxBaoZMsDRLbbizAiVSnNp0HoUBEJvx1FLudQcyvXnI72f
NMA2JtIPihdYAciEOa8RMib7ZpBJo4DBVWpda6MrLcZqOIXMfH89gHwmzybolfBHjmEVKeLn7Vhl
5GcW66Gy5Grme6m7G+r+lxf0PxUP/+CC0LIEj8mdQ+b62GpgHDQacXrq2hpd9a1Jz8zv5FNUsA+u
BwjCJHYKwB3e6hEkLsbTjRQuRONWcAl+PHWybXTRppGjuB5+e13zdIC/sbIR7H4nNxSCDmk9CCwT
3fBWEFuqAV4UnJgHH10RcSiwIeYAZf6jK8o1vBkDtbPsUQkz3xabpo62UZuOxFUZSjSz3552OqpG
E5toYhUpRzhTHR07VFi4pkivsGtD5HkO4yyefz7KMZoH8VSoPTrtEWye2ayOgLMGuEtEPlTL9jVq
Z1VLHVFvWNwlfpwb3Jeffns40gI6MRZ8Rw0bgbdryahNJcBKxKAmLQTfelL7rRBb8rZsrGyvDIN6
AjnzfouEzE6hDRE0dmPQXm/H80aqU0U1UFi3fN2Oa+8ehA3l+1baD3qZ2nKbnBjx/SxhRCRqOPDZ
5sCRH40YeErQpoyIiF22GA3gFhwRFtXD6JRe6IcXN20ak3sCqK9pnb+C7mlqWrUgyQ2b6LtfRFHX
4cQlN9f4vWYLTwqDG6PqABV8/gg/ukAmP6tgYtXCNXg7aqnHHjsITj7A+tqlkAfVXMaEYFHlpPuf
D/V+o0Ioj92dn/TWeJBvh6L4l7oEvZgF0hfbBnj+EGdW7erzUY6XwHSgwdSAhsgfrISjoCDFgCnq
jYQ5H7f+Q1RGAoT2JJ3XQ9weEtowi39jPHyBRRX1g2kDfntVIcZbCLLQrbMM1FJ8FUhVAyfgtmVb
QcHd8JITt/H9PCE2oHEK6J+DW5p8jV/Pk6AZhQmCb9pSh7Q6qGtCbwwQo2tV7rtNaVn0cwa96MQT
M+XDcdlVxOk6wcYdXWjdt1KJrjtHQJeo13E+SA5+wNlFWmr14wB540rIwFZ9fnffzxlZh+6OkgoH
HBzBo+mpBtZgCJVlTZVZehxVLCoPMkiZ2efDvF8F9FeAPAMftUDmyUfXRiGzRaBTtuis+coaUYYn
9qBsGVq9e+KCPhyJR0LBhcFgAL99em0ollRxwZJnolTRZqKgZ6tjhRRIK1Gk/Pyypq/9NqoiNqYQ
gmeMSMTzjt2se2Uj6WBOMjdeyvGoO5M7UOcpVPKU/ITQ0/tHBaoZOrMMawF1mGM5idDISncUUgAu
6JU5Yu9SKtYy68QlvQN4KKiVTU42XBF8DeBAb2+g7+d97KcGpVx37NxZo3c0zppBboaZLmSp5bSD
yT0NW8O/pa9SjrNCrIDgTRaG2MizPLRJLVHFV9BLxVPKHh/ehCmkQHNiUm48+nYamaZbKVy1keuF
gw2iuBh095QU6PulOBmiAk8gNmJevlTYXh0VJsBgH8810/arSNhlCCedeyJQPcms8qvBqIvbAHjM
Ccm295eGRAeyjBBzoLByfW9vfCcYboNqn2lX3NYlHo7JrLJi/8TuNm3Pb6YszAMGEaEcoh+LAc/b
UYw4FyKhryZX77R81ALsfuwgjqhEBXJSFLPSlTVh7xcheuYa8jn6ifn1bsmgbgSyhFgNftPEwzga
f6yCpNZzxs+Tctd4kCBANEjgNdKBbu9YB6c4+tMnHl0xZDjsu6DPixCrjvaexnLzwGebtwHlq+mN
6mbuaHN2eOp6lMLOOnE+vnuMwI51Eh/o3y9UPPntBcq5UsNjwxdSqjt5ZrkQOBAI+O1DahqFHZUg
HpGSF5fo14dUXHatiayLBrw5qlBnzaSlFqmVI2Wy5IAgyZ8KV2tPPLv3ySwSM3CA2fOIjBDUOz77
x9oFjuxNXSIPzJvU3wKs/ppaxt70q2staR9UoBmq0V77GWiPzzdbaYo+3z5I+Baw1uDWTzJPxwsk
yeQkCoZYs/XGVxfgJ7x1gnuME41af64XlNGMog4viqrplgIY4VXjdJHWPn7+NY6eL/EjfNHpaxDR
ofZ/zGcJpSwFLjkmOKakpp3XiOBSC/9NcsLLKDrWFlN+iz/WMZMzjrxhzAMrcbS+GBxkxtHnHiPp
xC092gxQniOr4EliLiDpsCCONoMglSHcyl3pWGNr4RDr6tZ9jbkSzliyUg7gh/D5WVR+gexU1wzx
eP/5vTxamtP4aHFMIQ/hOLnitA+/2mc12ctNf8QJlKaucMnJ0cp2pui9vBBo/9a/l5EyGmcbHFxo
dOievdO40SmRIVCj107t0YaIuPU+Fd6wSWzd6MxTSkIvceKr6cpwk7QaqwUAHrIE6tFO19MoLgMp
bx3o5gJwfKm1UrxNy8rolq0Y4miNZ5Elzyqp1IfrwuILzfWUyvxSt2LMi9TSAjaMcErb6veliGDB
TG1BC8wM2ZOuWz1L/Am5ZORoHaQdVk0AQBtjhqyNeDfEcinOw0jKrQUS67iK2DWRcwYUQVTDn0/x
f3qC/4CW/2pCv4Ng7rM/kvv0f1V/xPfp02sY5sv7/oJhIsZLpYpoYqrvTPnLXzBMlOPYQcCLE21A
Mfwbhil9IftAXA4HPnMq0bBwf/UKgWFSgjDBU1LmYHapxu80C42XJfZqlsqEAXwn0kYOR6brsUFD
3HYArjVov7hPrMNgV5TK3suzhyyH3+bLMZsCgDJFv2lcc0NxcoNswFke4qQdbdFW0e1RFL8bOf5j
gg4MXel/ePQrhsTbqYDCgAThvr2QsPmq5Ttw0IOjBhm+wEOcO4CqAcNV1S7VNJqR8BxktbgHrynL
q/DKCg9VtCyBf6v2kC9cc67jLbexcpi2S83cFOb5oaZ/YhhnMtxsf4dkQbMs1HmC6bY3d2tHluwO
lHi9GELbroz5ENK1WIsC7fK5qM7y5tyKLgIUDbJLN9zCoCkyR3NnU+8zoiCxlKN9aS0sdR1fxVfh
DIoBPIDn4kYRLwFPiXbiOfxUIg7hcRcv4oX2TXAxq7KTO+BQ+RUFE+Df14Lk4LZTeE4V/PCly/Sq
NO3rIt5nwld6DUDtRxtog4fpWObgciznZ0W4FDHeGkOnEvql6wUTcsv2k3G2jvsdSiorvbnIBDhE
i6IxtuDU4zR2kI+ypSUGBLWMqq/T3A6Pwp1wNzyKL3+KL39OP/37+vnnT/9efqyf5cc//9c+h/e0
gpfqY/usPmpsROAoZDatYd9WC3dYWMsi2slGaKtWZIMUt5UGvY9NnOOutw+rhUi9T86+A9UbUfYj
e76N71XFacGMRddIt1324jqq57RQbcnJ1v4475NZ5y2tEuWSA5r6krbo/BnkBD07lNiUjQewFoiM
8FmGtORnQzsxO5jlyqCjMtKisxP0lO1UW/jCHH2F771jAvspY1sZnHFT8G7+jK56py/txrKtu9ZR
D3Y553XmfabO08E27pZJuQpzunwHwIy2P8wVET9lxzAcvcfAdzacc52+6xSwuuqZep11tno9nPsP
Luiq6jwJtka66eVVunWxOln5jeqY1WTXcekJj151SPSdvI6bhbfk7Zn/te8ve+VOSzfnurgIhVum
qqeys6M0L3n1DCU/hxPCMYdsgYwzgtpIgBrCrGnXUTTDYzFQtyW4VaU/95uV0i7FEZzNrBDmKRcM
Yhkz+eIMxoEjAIVxcm+puWeKe5bvYsziFuomq3fmxZ1GLdaCSuo7Fq54G6xMvIxF7QzydSWcV7jC
JVMdv5yF4jntv+7Zvw72Z7PFzIw35vOi6GcZuOj7M8HWApvKq+WkKh57i8C/wCiuVZ1qj/gifqXj
3FJ2JbiDa+HQ+nM+UR7mmjevhnkvczS5m1jeRcmzG3yDTmJHA8zEXeeo9T3ciXlFM1wVgWZqpPKC
ZmtIeGNeZRcvIEQRIRNhZfnbuA4dKXjAn33WV5sS0G+9SwGI59HOImF1aZfy3ax6np+L94SvAays
r2ACi8ukeI4gdXiDk8T93CAGuRwJE/wc2c3Rzk02mAOAxLASV+lTAGSOGNcB8ZkGMMdqywEQx9/N
pwPYBb4aTzS0+zX8Q4VWjyMZd5E7OL7xw+qEb3W4iLVVnK8HZTvJUMa5bXrXvvRNNTWudJmKiyj9
mopfxXieo7y3N+/lkFKzX+EL4Mjjpou3igzaypyTmtvpoonPxeGatr+aL1pv15wZ3zr2Q8nOLpIL
S0QWwx5UKFHT/0kPzVl19vLP/NvP34hsr6rNXoWruEfb9dd/WuVUP7IzxD+rbs3GOG7Hb0NHZ8KO
6DbTqJuh5goW6bxQ9+DDpOGBaY+ilNA/YMFHO3qvDbgnyngPznGMChrWVIF+oAh6FCRHLD5IKXhR
4dIoBTzr114ukAem4FHXFSwrS5s8SwGDDhtXXmCMXWo3ydzt5p05iygXh2MTsFnrt5XIvkocl19y
V1NKZg0TA24/1Mn0AUtXRp5ZiT1aMsDSrLVLa5lVdtzYNLKt/Dbu9AVKIvDRjByLTdu613fhQ4Ov
aFQ5anHmZ3vd+5pxJrp0y9IVYaJhQAtajPscrDlOzaPTy7cp3lA1OYHXCjRy+3lgsnaAKpjyOB8i
+bw2TP6OFlhxT21qnm40Fm1Qf1O1fp4jYGLV2kI24ANk7gK1vmdPi508ZIuljBI2mW0hUxPJN64U
PXCafw9jWhC90NsqYBWgPrOygZaNtKnb6I6oDvY4XogZbXivdTxLwT9echpVWlepPhfifBvrIsqo
5kwRcL7IynnXPXfezqzgMXRLXUfsOhB9xADOBQWBfh/YrU03e6YOwUWgpepcMK15H4yU6VEYs6Wq
3crWIemvJACL2JnMI1mFaFfgeGDQNMix3+zacSFQuRX6O/Cj+yiUdr0WH4y4/4qj5pOcggFUD376
b4Smh/xHelWXP37UZ/f5f01R7WOWgxLw/Pr/vv0rroG/gt4p1Hvzl/kL8+ai+VEOlz+qJuatPxuI
0yv/1V/+4u9cDzn8nUcAH/X0aR6aSq+Dx0mHk0bPP3deXGbEm39cNQ9PQVWXwWP9wbv/Cj7pWU59
b5QsyT9+BZ7aFwoUFJkVagfUYl8HnsoXejE6cSoVQHp3Jtnvn4EnpouIUxPJIq+s/U7QSQr5NpMn
6GQ3A3qOMATK53i4v837grwQNKpDolO41mgXia46sYWkF34Q69aMF6GMVL4hfYMZcl6qsKJAdw6Z
cUYFVp1ndbXVEn2VIDKG3d1BEPRN1qp7ahdbs4u+Yn+xF/3xpu31nmPQ2MTUA9qyWklRyxKWHwbR
25SqeJmp6FEIEb6waqI9JXS8khbujSI96+bEcKmSbhnHYK2zMHwwokj/AdW1mvBRsnTTp1az1LQC
lh7J3aY1jRp8v6Sse5/eiBjrzdc6KlBSleP+ThxcedYrSe4IgNUu8Ox9iKp7L8qzA2KYRBa5/piL
AUbvIe68Q1klG8/q2kUKQfQA7dBfqWEFLiCnNjy15WAZKDi1lnWpX/ZDdOWJWvYIl3TizqKAIWC7
va/DRgMbrKRYryA9gCVI4bZ2lJqg61PjW5GwDQ7wmZxQ5ShLzNh3Bq0EkyLm51CY10rYJ7YbFtHS
aMqrXGbbaxEveNRid15mvIY8dhMllXdhJfm6LmA/JGyrtBEcN4uWVpsQsDfbMMkc8ELriddqRNuq
i7ZmCPtFKZ0ygWdQrzNTAUOXkvJntqmN+yAo7Hwg2Apd/+vgtbwg2/sqx41V1iQeefWgecYilZtz
Hv33Ph/nXe45knkLBHAxWoUdqOl6hDhDLCQYkDcsh7I5blWpbXFNKmCe0NJ3ki8guNs352kxpN/z
UOcOK60BqUECLfdYKaM2CzVCVEnNq7Ukp9FXZcIQxam7R2FvXY5xuehT8a5HVvvGHfKryhvEVe+G
4QERZkXINpob/lDbbeWHCxbbwgjBeQjyGIGN0K5agENM4McyquJzYhttVTXBJkSRP3L5iknRCgjV
0GxS2mERSejtKVL6xDwQnNHopRlfK1rIoptvkzg+xK4BPk4m7akKbdeXcrJW1AEol6iOjlFUNCBr
76COY2p7kY/htNXdUuQ2nJed6LdqAf9pGy568fiiTg5q/3zPvW7Shz/W1ZToV6+327/f+wsKrH2h
MIv2xgS2mSr5ZO4/d11N+0JV+KX+RKELoglb699Wt1MlHpAV+jjIq0wSZ792XVn/QgUQXW+FvgCW
AuzVf5485z/T+M+sbo/qfWhU6JPyEOcBjSTa+0f1PklOWB4axGpDrJ2oUSu7y/zbUIkeksaHbYYw
0QIZgFc36teXeI0ik46qfC+jArhSX6AgUFGPRuUfAjx2fW0m5XVm11gdUieAwzwEyaZVg/1QZgSM
urIMk/gcBRsDegkZVVT6NyG77IxzZHTENFQXvz9Xz4LHMquy5/ptJPByj/8OE/7TZjTP/Z9P5f9O
nwAMEkhxbsImXj/9n3/w+p/TV/pimJQj6dHSm8HGaarB/5y+0hcKtCLuKwiQIYoNOOSv6asSGYC6
kah30jGks/P39OVXKp2m6YNoWABG/63A4QVq9bpYxaTFHW7qjdPzgAPGEnpdL5YteKqUMUPbdTPx
IcBa7Fzts94e9JEMRaSSi7JOtnYJt29aI65Xk5jxjVvkuwIn0iVlVSJtiIq8JkyG9mConWmrLfJw
mLu2RNKqOacjZVL0ISoI+/YxEcs7FInaWSsMF24et0tDQRStbyzfGeUsWsf62Dg0QCHVeTBzSym4
K3rze96NISqMynbo3RtR95VFWg/+0i3KrWQmwkQBvMl1qdkDufnhWrFdZCM8YTIldM+Sb8XQtvOq
GIyNjDj8UpHxL5cSCQFboTLtWurrR1UQL/kqyVmLflCXdSVUz76yU+hn9NYG+eCNZrBIJIpfaTXS
JbGCYlI1aGeukMEb6eptjYrBYvCaFAtTfVzUXenN80x5ytSRvImSuB1pybIx/fY6jPNLxcuf3Ej4
pqLrwJ0OtGcBcqfZB/61G5XqCs3blZXJ8YqYqnDyJB83Y2umPxFDv3XCXGcJ/326ZP+1hb38kU1s
+ur4o95kCf9/pAW/TppPC9L//dD8cdZUb9b23+/764RC55/AHxVBoJNYN/25xDmhRGxEcLqB309j
xqId8+cJpX3BCAk3SOWldzklAH+dUPyKj8FbiOCTcxRey2+cUMf16MkwmN40zXekJuh7GUdLXGgw
Mp08lyAaextlIFkeQnfmuwr+UsTdEF3DaN5p/pUlUUkY9W7VgqaFAQFxVYO9qo3SsOo9fZ2OnHGV
Zmb/RoTzr02u/7RTY1LV/uTYaEg27+Pg7eTiLb9ODs2CxMTsgYejv+Sbf04rYDhfaGTI4LrpMpBS
/h34CLyH1jxqljrC1eSckxrir8hHUJUvKAL9eQ5Nx8fvTKy3oY+J9i5oLgDmSE0AJEOR9O3R4SWZ
UVsAd3fGgTwg9W0qW91tls/SU5bXEyjz70Pq/UhHfb/Rc9XIoJO5iwCOBVS/gg1MndHJpD3iigIZ
3KvH8EF8NeEXPhtv+v2rJip9Rk+MFcarjYNdmOs2nrl9+G8MguqFDEdtwqgcm0jkqhpqApzMHdjv
WRjfycljKYWYUv+ecvrPuwfuBmQPm8lkePD2ahKjDPqh9eRdWpnrIsip0kMwyWef37O3IenLKOxm
QK0BQGPsJR41nietKC1LMopOfdtd14ObQ6hFwSKKK2X1+VDTxDp6PAxF8I6kOAWPaVN9/XgMmMmp
hwzuruhkk45CPM56PPtOgIc+mAQA1EEKAK4BwHWsVAyZJJewgVR36eROq7QoyXkd1uS5mSPqUJ0y
B572+3dXRQWHaAx8AqDao6uCSCwUoPLVna6KjewIiZHcZF0mUfgOehpW4AjNGO5b2cJKAq+2iSKv
vG/KpI9mGEVVGhLOmtvZgjqWsUPx1cBUmDR+IWlQTSiwhuE1LN8R5qsYPvtF2QUz4Artdy8wSPzb
AdxOiGqLhqsrvzwx24+gJj/nB4K+oMCIa8nLjmZhU3Wi6o2NulMohM5riW58BBcL3ra6Ekf0Z1zh
kKjNXY6A1CauhMouSlM5lThNidHR1CGDZD+dTPsA/h3tJDDnCx3dDnUnK4I0k6m7q1Z9FmJ/Y1dD
uBDEYq7ltZ1a4tovx1NL/qObAACOJTLh9/FzPUKfq5khujVVkJ1KoQpSdj5cpNJlBU1prtZ1vAtC
olVTLGaWHq4joVQOmtHrJ1CPH3wLiLOThNGk/s9kO/oWtSmHaLU02k6WouJWR6RnBSj5O/L50Qql
vm4+xGJ01gxjsxSKOp9LbiCtqj4+ZTH8bh1TQ+UIIzph0oNb4+R7vY5x0KmUzsyELUrZOvJiRn+F
eP8pudAjiBUzj2Eoi7M10ZSfVILfDoOcJUKFCP5sS29muOOmN/InK0JHFiCBg6sZIiZoeTDdgjPv
6jd3qmloSMPwxYAe4L/7dug+kyIygBEJUGlTEl11+gnt43eb1NsBjtkTw4jEXCR3wlamoTts2tJp
rLWondgKp63nzarBpwI2NuApVcH8Z6rrvH5QWWxIjQWkeVu3ikRHULtSEd0JEMOZhSE6cB6lzvnn
d+6DC3sz5NHcqMyyTKoI9qNxiIvvknxjRjeVcvP5IO+23KPrOpoZHQq8aEno1tYT77r0XpPWXXzx
+RAfXAfBG3k+2FBu3jEbA5tS8K5q4O8EAVN5z3QsuXF676JV2sXnI32wmt6MdPSQuipMJXkEtdFI
KFhoJpj+/tvnQ3wwD6ZIdOoJwGVBvf/tPCjMVu6TAn5llzf+EvWMtRl51RypR0RREUyo/OAUhP+j
q+KwB52Dryb+p0dX1cZDUxd5zZDeJILTfS914/zzqzo1xNFUQ/FwoNTOEOVQ+rZioICYa6dCynch
LD4cZGA4x9AGog50NAjItabM3cbfsVBdr92ASRs4zmumQWptzeIKYtLs8+v6aOqR+5EeiNKELz3a
fBpxgNKqMKQnn4keCBbvQsDwrvLsz8f58P79Pc7xFAcQFxqTk81Oj8ql2kktaA80NT4f5F2yMd0/
4kqLHttk7XZ0cIsxyD+tZRDpoKfzDC2lIT604bA0kUssTgVjHz6tV6MdTfQkijDpzAZ/l8CFkZtk
I5Ui7awB/Qdl5oaSXVa5o3XGiU3v5eQ92mjfXOVRDCgNeiuAbGAq+pdiUS8rarVesQEc5svybVsM
iJMAe5RKO2hoh0dbP/7h+aukcp1AuOvKsyR47FqV1nJ95nXgS7J5qEeLxIqWKHkt+wy+NpJ+krDy
yuHETnf8hNBvp8EIP5FlStZ5rJEBXRxRgCqK91aEp1HiFBnRnQnpoZqV/XcTBYvfmxHTeBPQjqOV
QIYt9u1mpNe0YdIW1Jc7nnnGXgx+6Gg4g+/Q704i0I/csIC3ToNhckC7Ad4qylxvBwuQVcwGUWCw
6ivlvwThHwgxYQu3LpVsAHDsgY5QaHN5fBxOBWwf3Vmg4VSISXosGrxvB0ctAQUn+qh7QfQx3PDP
EMJJDA8oXgQaaT7kJ6bhR+MRLuEuQNeF4Y723NJTlKCX+mRformoCVsJPInrXlJJNWj6/T/OzqxH
biPZwr+IAPfltYq19MJqtdSSLL0QkiVz33f++vtle3BvF5u3CA1mYHtGgKMymRkZy4lz2q6rNj7l
8rqJ3bWIxgEvs7UMil0vUCd5rLoMoq8EdjAIq/zn31PIP38JmpdAazesrS1PTCzSTuLEAtK+tjZa
3WzLgZNdZonh7WQHRwot0ByW6nnf558grN94YF4nQN5ea9ZHIY9Al+obEwZLDwkDDFe2kfLLPEfP
JpCbDvjLBOyxe2i1l94ZnlPb9waNd0c7yFO+Vx+D/kOQyV45wwxWGe4c/S1F993Gey4Icq4Cu9cf
BjiCG8TwAXnZ9VY4QTn7AaS2FzuP76LeeKjb6ieESr8McDkIHwwcOMPXjnojnypJpT3+xP8bhCO4
SL04+jXYmHr+IMWn9j9FwX8hHh/+3Z2rHtcy2BC/zUI6WfD4gG1YJoyaWQ/g1qXiYpm/R396mlX4
z6VdX7xinPIYiM6zOScg+EJ0tM46+CApa3dSfzczvTSjRnLb3yyf09ffwwUkn6Bqw35d71Wc1dC5
DUF28W1/b+hdyVRG7qF5oMIBtJE3rK79ja3FO1D3uWz6s55eLHjFuhMzefuKjW/AFll/Jjv86trI
jP5vXYvLlwVRCp2ClV4QwYDV6zCpnyS5PebDxvvwLg973UBHVMg1oaSwjEdi4mMbFR/cyqCe8kQv
d3JW7CIH+GUi77sEdrdUO84+jPlZ8nL74y0j/X9t2xTVuX7vq1MkoDAV9VF2Cbp6D4X5XTLVn2FM
3Dgji1G/fzfTlsUsHdm96FpfHxLwMOg/+E120aLYq5vxIEcDI1mfOutnGjhuC7gbKmpEMs5BM/zQ
9c8pfZ3bS12GY2KpQmyU4hXBOtX/659QdZAkQfGSXXJZgfRlhG5lAjezsdI1z8EojSgzQ63wTs63
j5pCTloWGs7mL1mpPjVT+5C1L5M6udEke0agftOAEN9e29od5BXkJUSKFkmaxb1Qy97Qq7TKLkWA
VnoLjpxiWEAtGJzIhtNeOzEcVKZ5KP5RNVi4RjXX+EJDywIbWQHu50iHFFIMiiFMEd9e1aqp16cB
TXoSncV724jHMQo7YSo/jIE2ETM1jxH6Af+VIfHZ6PoaRGrXRyNFiqiNrCG7RBrY3PZzNFhum2yo
Bq2tBvyAjlqr0ENbTkBpkh7Cskf0AMzdPvSW+muoC3lntubk3t63tZMuGGAYKRUasUtlNz8rSrn0
CRtqadjP9nNBA+K2hZVTLnQkoaDjPjGkpl5vmNH3tjNWRX6BObXw7zME75W9T6//VEpT69+FkgZX
sORPTuxKkFyceJ3kP5u2fPUpzJUC8qT8YguFq+sfUWkxeWnb55c4+QiRw5EZfWcOz7dXuhYKwFEB
6Jt5clqYy1JVBgubbVZVcYky96tz6He/mQ/Yf7h8/nqYdsnuS7eDxHnDiSxUdf6ztP8zuixfOaWd
6XGG0aSBB9mB/u4M5fEOiupDHd+BAx9714kPvn4uky91dC8B0L297pVgEB6QV+Yb5uVQqL/e3B5O
LN6MJL8ksOserSgEilfq4y4bzANdr/JYmzUEvBqEzLcNrz0ViBRphL4AeRg+X1zGLBoLNeQvF56r
8kclt8OdWTBzJsvFcBe1wKIlh35QOUXjzsgqcz84qJhGSpw956Yi7cEhNhvudW0zqE/QxwbMqvLD
rjdjlGItLS2IUCpIcB/qwoGPnGDoXi0r+T6onOBQDyXEfHoof7y9GytOQwwtMuMriKT4IteW5XDq
4ZrNy4tkzEfBgJ3HiHPIp9tWVsIqg0RK4ZwbFN+Xk9qyE840QIri0vmHirmo/vx1MP5pi89/boam
PfOQOFrB3LRYDOLsvI4121gmfMU0Jl5kSmeYtaeiBwJZ1lqzcYxXHBUUAwLpRsyBqxB//qZjOWfh
mOVJUV7aQbtX8ieFyKpNLa/QUG9Lz4yzOPmGybXL+9bmEoSWM5YNMWYlbH6yAy+Sv/f2xy6V77J8
5HQ+AbDdN+qHOdLdLH+pg+JUbhVMVl4AfgJtaFEEIKdbHBtH8YG4zn1JMgWP3fi9KbaCVnH/F6mb
qcKqjEYkrAXW8o2RU3lI4DouL1VyVuKD7LhMbBjRoe+/DOkXZep2QfqSgp/YEMFciXTEsLJg9xC+
31lcxX4yRx8Nq/zSpWpzyJjb0ZJOg0CaCmtGC9K9fWTXzg/QAGbfuXsGUc/1+ZGlpOgy2AoJrLq5
2pkRHEWBX4TPSt/s4MG7g6FXvUO7tdoliiRvxForfodIlbhOl5ndpJpzbb2w7cmKI6m8pBBFG8i2
JF6cpHBrngeJib/B3NjclWMDeoE4CPQZsfJSrFXzp6TXyrq85N1XpWt38bDRYltZkCBLocNItoNw
xiKii1MzU/uZ6xhren0OphJORWOcPjRamlwAdAVuJqnBya4Ca6NVIz7U4ryK8hQoWSbQ+Ys4z28c
waCNA72TubzAf0WRymkf+246x/MWqGBtC1kfdDBiep/axrUdALGdMkAvgeTGuId6HVHvw+0juVZz
E3QkJghdmrXwS12b6PMEfgKnqy5BLt3bOJl+bveVhQB8jZJ28TG0mmQHPypkz0wltemxzbZkVddW
KVqkQC0VkBr64idMph44XZRXFz+J0Md4abrftxe5ZWCxjX1jz9BDpNWlyR+QFRuh37tt4F2zl3QQ
gWyuNhqTYgpFu95FWMBhvvX5UDmDxwh43jm+q7tFc1aPRuYqFfzuGyZXXllaNWQAABng1XEWFvOw
gghyCqpL5veXNJQ9K3vwGTLR3LE43l7d2vbRGMDx6xwUso7rxWVzKdsl1HeXwqqVQwEz6z5Io43L
vLYeYhPQJhYNc3N5CEwarEVT6gAWStqrs+rKjFubTK1o/vA8JuFGYCjO1PIGC4FsSJAEcfWSc6xG
0sKe+qJGEwH++mC8tzr9pOGhd+HGwtZ8BXtH4iRqy7xyi93LQpmsJqmZHbOrA7S+TwNs+ec82jjk
axvI+ynj37lL1EWu7cz08Mam02uCu/Q4SOFFKU8THNaaXX5kKO6PjwStQlIYwYIBdnJxo8wSYdXY
hN3f9NFlccZ9Hm/B71dOHZUBYgLid5KlpUplkg3TkFQc8Br6OyitEaNgHHurv7FyDgRsgFWITitz
Bte75vj4v1Qpqota2w89A+LSPN6ZZub20en2lq1YIlhVefohaRMdjmtLklmkKWTf7SVrbVePfrXF
Fxn5vUraYCZ8v290InnfNbp41KYU8Wq+eZtUKStzvS+Z/5xl+2k07OF7UFHTvL2a96GMAM7yHyQ9
qUEs+azkSI0HBbG8Sx72j/qQ5/D3+wp6861z58co6SFMB9nW2CB6007O4bb193uJqyUmhQgUhwHe
7nqNY90iOGQrxaUZypyCbWw8674FfrAYx3tjtMKN1a74d+HbqalCmEYZcxkojmqrOKFelhdtCErk
9aRWeUQiwd6limQ9jk0eP80NoYBdo2S5NxsGfM2+pEmbD0Z5vL349xedj4vH5xdxkPgM14uPzGwI
TYTyLpEyfQEx/ajJ31LziNYfKL0tt7ySQGMNZADYJFoXhMnX1tomCYcayuhLgoOG2aspq294GAMi
gT5Vn8eioKAt5ZXhICcb6X9B16erj4M9MGw+JIzGgcFA6a+AKXmL4HbtFFAAo4rCh2G6YtEubBjV
s6JKLi9mspuCZyiU6mhfDxux3tp268xECRiiqDkvtjuuAyjEM59Yr2nM8xQUPqQEERTZSWy4kh99
kuJK3bC5ujKBSOaFYuOXSV8/iamhmHCircOjLEkZ3AjZvVXF5b4yBYz+f+HQKz2g92G0KL6CXCX+
IlBHxeHKYShZi+SairEGFTLRBHFimCem/eQnO2gdD5S5Nx7fNedBuG6CUaQdSUZ9bbEgfCYGwOk2
ySdV/l4qh9C614Jde9/ov2IoyG4v8P0LzALfmFt8waFrHLnzMTfE7QfG9s8jlO11uSWxvnZQgIPr
op1rQfQlHPMbx6vHQVmhLs5Bsa3TkAbHZpy8EXLKXk0vMv3s26taNcd7T3qFn39XU+tGKerKidNv
J8opCoMZadbu96zZP+Xp77BMN8ytukDSLTFOgbIo5L7XywP8ItfwxJaX+jFJ/ulc9VhDafB3g5Ih
aLXPn2+vbu2b0ckVvRU6ue/GKZKkkxrgv+VFkced1ZiQ/8NjAOHDbTNrFw3EkCA6YkaMjuP1osLA
rxwLXduLn+r7vJFLdzKCb+Osf5J088ttW6+91OuYU2dFPFyihITrXrzMSmP5oZSoGKMOi8zCORyg
SVEZANtF2h4yOJg7jur0xXI+yUzNDgbB2/AkW94UHW//lLWzg1cxaEgSw70rduftWKBfZ1eXajqo
5qWJHpr6xQrOhrxhaPX5eGtpcWoSpq4LP7QqKr8709p3h2KXwt4oBhnuIKPxGbxuXFjNbq9vpQvK
VgPJotZJXgZ74vV3jdo5KQkfqsssm3sIDe8iKbuDfPBO9hlEd6B298fPcZl+nsutqsRibFSU22kf
CJ5+0bWj+rFwNzUq9WYaz9UFYQCV5CKPGGT32vpbZum7IvZS5SOignKJmK7/kBSx22XSh6nbyjtW
vjGBESfNpvAtxpyut0CN0ooeETufTaarHLM9fEgUGdyN0GjlouLEgQ+YvJECeHFtxiqsOQ19aN86
1bq0crSL1Ic0zF5uf1DxvRZX58rKwrdORTWrURbUlzhN701zD3YNBiDj0OYbB3Z1OZQh2DD62AQ8
18sZgiKCPbSqL3bfHWT4grpSvWu18dft9ayaAaUIzheQ57tpEakLqtEHVnxJJc1xa4qj+6RK2xMq
yluv38pjK/KA/zUlzsmbZ0mSS6OHJb++hD0HIPFQBQCPLX2KWglJMIdZScihCn+rqbe+QiFZYcHc
x15em416y681I64vDkFqeo7+9rdy0NUzYVM4YryPlu4SBWD4BWE3aoYkvPFOBoRXEP3qsXNIio0U
fs0SfVymesjgcZpirW+2sKuaZpriur4EwCkQv3G15H7Oo2PV/r59LNb8Fpro5BeMpIEXWYa0TqOo
0hgM9UUplO45Kab6iBbd/DM31BZOuQJhR0V/6CNrPs6yet+iWLFxn9fcBkP9sD/yyIMJEnvxZq0x
Y8G1MvALrCR1TXjgivElkI6RpMPZ9l9ctre2FkfTlDK/y9qey3bqzd/2k9X/vL2fax+OfpcQjKBz
Qah5vRipKC3fT+b6kiefg/SkF98l59FXPt+2IpzP0jm9PjK6INVGCuPaSpAa5dBoSn2Z21NRnjTt
2+1//0qALjj4KR4AymVcYuHJUUaXzDYhSIGqOnsKWee3DJIOOeZ/VXZkH9I2lRnErsyNs7B2hymO
EKjTPQUBIBb+5iwEiPmN5sAQUdodEIgywme72WhKrHmntyYWV6vu0y4PDZn4IKXrkVtoH9KNzaeP
TAwdZPlDirBRdbq9n2tHXJTiyOXgrcAFXy+ra6i482fVhRvUG4zI698r5D6gjdPRhb5ta/VGG5w+
OCMR+ICz9tqY3MPI09tmfalL9YcUycqxt2yEZXWjchMe1aOiJUg1ZQGCSAEoty4dnB+3f8Paeg2E
kESbhBR2SdDvZH0wxgz5X9rmHm7eRxKYT0EUnZRAgYlyY/hr7cwI8XaGBoVJc3HlYpolzM5F7SVU
0gOvTRbuUn+L/3ftXr81sgg6giYHLauG7aWNkKCLTzOMX8OOuf3bG7dmxgZ3xWqgxAWgcv3tJN92
Qr8rCdhRo/VUBQkymA2a2NFdBki3iHfXrDFvDJoHFAxcEYtj6be5XlQjZXaOQYV0VS8EfGskhI3q
7Jtt++eXm66n6Mu94l2WVX05RhARXVgEWhEDdhsTmThaQQmwuVDaMLWWBdCkZ4j6dU6fZOt6IxXN
T5yw7tqLFSIMVlX/5DFo7ihA8nUaZ+fSztBV2rOkn9NO1o6oredPQ2jlxzALbcCvZb/xZVdOqRgT
4mJSXuadW7idKrKnxhrjhlcO2BnE4FrfuTC53D4/a5efBg2TPKKyQiayKHQ46ljBTxN2F/PkVPdQ
wUbVQ2s1NNbuCmRjVPTiiuzuttGVY4RNR1CaIDBFv/56rxsLwawC8cEL3Hc2PeZLWvzY+J4ru0dd
URaj6aCauSHXJpB8HHEzTf8aUnbGx1LRYPuT93++kLdWFvehSYNKq+e6vwxwWU5fOghIlQ8DnfLb
ZtYWQ/wo8KSC3Gg556yOsZ8i3jxcTGShw/sQGvotnbiVT0LZmDadOG1kSgufiNJ9IdNbGC7Z7CHX
U4Kl9pF5dvLucHstrxdpEYpQDgd9Q2leJGSLqLuZUOgNpWa4dDGY+yksH+vqK4XxKXS1Ids5KRSS
lKk151xkysfaetCdbz3smerHvPvJ3ORsPhU5U5p80FqnTvEhzZ/M/rMZmftoACXWJmczrp5v/+q1
7QH2Jyg4IGCAn/76OCHRbaETqgwXK4J7xnEre9o1xucIpfH/xhCHFoIrUcldBFIT5M2paXXDpSmz
k68+9JX2EZbDD1OQJhumVt5cYAnUb5mcx50vves4y+OYJNpwmU5BfDeYxokqamwOuzraAgm8Dw8N
g8FHeliU38Tg82L7+nQc5dihDN6Dk+G9aB9iNwr/rpR/Sumf2zuo8++6Pl/wG0CzJD4VnedlqKv1
Qmk1UsnDjXE34sNHYyMgfH8dGV4HXyX4HymjLg9DPVdm0GSiGp3WqksRbTfoUcogxLARqLyPPDGk
CkIZOgfczMW2xc1sEvzF1EeEmqkcNsCP7ROUX+cCPmekdy/DU5+kG/HgygaKgXjRtBDT2MvKvj9a
aTNPJK0KJK1pbX5XnHzDCaxUaoFzkD4yWMQugqi4PhCj3Nhmgm76pRvn2U1nOM4LK3sy2zB1HZQm
9pCX1W5S06lSQ7txRwhgfSibN67A2lJfAbWCtI0cfXGtuzIV+qCUUopEOSRSftD9n7dP48onpNtN
eYuaqpC2WDyvNE78PmwocZUl4pSRhnRP0lPoqmGM1pXWDWz9H18F0ylvwf/fX29CeRpjYmEUN5a0
FVJvGNT5rPoSBSkKTTCNh14gwGtJ8Kjpn24v871/BHuHIoMmRlspaC6+J1y6Y6vZWX+ZADfeIf6u
u6odxm7YwpIGnbi88eFWFsd2AnEE40joYiyiNbULCyXrC+wV7RnM2NfSV+GjbxDx0qf+Xk/+Q2j3
/04hvfdgLPCNwcVJqRNo90u16i8ospxVBrVCKMVBV82c0MRXT4yQnf5oS3nswcCR0JJQi6Hn5Yus
6IE2jHZTQFmvWNCwjfmdMaT2XlfiGUJuY6thvfBqr/aoBDMUg4SQ4BS6vpKhMtiGj0iqZzHWp9M8
jSjwV9b326tagrlezehEs0zBC0D1Mtm09MZOaRxiJi6E3oZu3Cs+HPZtXJaQbw7a36jdJR/7IZju
lGmyHnxFH101H4b7KfKzDQ+7OEfi1wAWEnp0ZBlMRi8iUaekXwnTReNJ+tQclTn6jBLvi4lw9s4J
Mv1O8uthw/et7DPPLagAOmLs87JikUPrOkea1ngaJ3iXx1J43w7hQJgzbwlSLbH8r8vjBaRKDD8N
74i4tm+qI3qRaV05q60nhQpSypPh+GBvO6ZWnSSCWSWITAaCjKauv4ZF0tsHSSnRGys0KfjbNxLj
r67ppeekm9BVyLoZgV/TnnMNaZQUauu6Ruwe1dtcDnexGZQbz+yyGfX669GTFKQdgidmeQMY++N5
quzGgzGjHHZJEFfnwJozt4BwKkEidIBB3w/yY9OZxQnpLfkHkMdW3YVQEx6lKs6PiHl393HkNF90
v5zdvvTrjc+5TKBef6Xoo4BWp4/xrgKVJHM4IerWeBBuF5e0iuvnRgoAh43pvIcQozpKkF7vDTOE
zb41JdQ4cmXDV7zemjdBDz9CJMnUM15HZ1/p5d5+6AKWJTQq+8abfaix3Ez1jcBVx1lMBfsWtIVz
ETVfuN9+dwwBG3bHGmwo/DbTGPwcel8DYDa0FZGZ0ldPdjYZ+xrlkHsbkWXo/FV7Elz6I/Redhia
+c9oGvsWDcXcJ0/oA+0FdWhCLVnz5/mQjp3f7DpllF9uO4/3VweaViGvBgWJQIQubmsdzZOZDFPr
ocRVHPK6UZhFJnXoDWezzC0C7eWO8q4QH+OB6X4Iz/Hm6nSVSFJlGVtIVrooZaravm3ikGEM33aL
wPc/j1YBhFIKp3OtdVwEdf6Wakyp3F70exdF81P4ZBO6CBL1xQ8JijoqJYPzVVijczCG6MU30+Sc
DxGlnngXmXHzZ4/r62GiIM2AK4yyvOULr2E1ulEn+tx65lzCj28RdrWzHu+tzoTE0gqGE1C4LQWp
RaD0r1FwjiQHQhp0WYeI+sBmeEppvbyP6mfahpELkUnhWhXyBkSDzalTQv0UTlO492czv7u9y6vm
gfZzj8VQ6hIZITdxlHUdnxv9vHqvG9nwLfcrZRc6+i+YuLM7U5eafdLD4k1tdgttsmzIitXTTiFW
40UUaPRF2odC9YiYj9R7ptxEn1KzKUluEchAz948RVUeHbQxmuBGLbp9QPR+RKxK2hPmfNQA/uzb
Sq3cIh+Cr1bfbnXnFqHP628jUweFCmQPGrTFrZO7kdEsZSi9IKDyYLdMcfSIqZCdKLuKwt2zTSPt
Q5k62v72N1m57vQeRS6nMfeG5t/1FaSXVPa0Bmuvj3N05OugYdjTkcxOPvk6F3/jCCxi2Nd1gn+l
s0rARXt8EQDNVhcOMXMkXgEA4jnVmfnSzWba20bJdEdSGtHX2+sT/8KFi2HMAs/IbC4TQss8Mgri
MJ4jp/YkNUbCQRw8at9b3bLVZYniEbUW6rZLPj6aNgMwtKDxutE3s32r9FoN8TnuX/oQ+SlEW8wt
asO8kUWumKXlDuGp0G9V3oU5ZjSDARSLU6fvkMG5EuDvTOpdKWg3UqyV80kYBbcppVtUA9+RKpSK
U5NNNl6F+E2bGnvLbA+wYrsdeK3SKk4N2nC3v9xKFCuYxGjaAckFLfsaFLx5HcqhzpO+63oPz+R8
RVLk62imxaFMM8MNDUR2nFGDe4+wdZfEUrGnHkZjNNKR2Rl73zze/jkrBwnCQKDIpNL46+X05BgX
pd/kc+8xzqt/RLxxPqZ9s1WNX3GRlAaRroBEHYTkcqKkpMFQRZHae4mePSH9eUws2Z0kC17Yu6Ke
wp2lvQx6uBGhr5wjqkZMKoPwZLeXjhkKzjy3hrr36qCDUAhAjtJm3+UmPFf6+fY2roTLjEYwZCKY
cnlrjYUHyAqy8AZtT09W2uiT5ksdUhhS3Dv7GHHcJzPu8o+Jb5do1Gv4aVcuG3CjbV1lv7RAT46D
XFgoLCGvFpTR+IHi9ze0bpQzMW5zh5q38qHXQmPDS65tEKyhlFRhDxfjCddeMgAf1o1lMHgtUzGD
4SDEofQ/tLEq92Wdnm5v0cpdo9LJVMK/OiNLH1mag5bVuXinRsQopnpGbihNf7WB+j3sW7cpAWXq
7Vbct2YV7nTGUSlQG2T810uMO7OzOnTavNo0PjXZ41z93aenxCcOaQ+GHG5Mha0cdHyWKLm9Tvwt
k0J7iEtpbIvBa3oTvmPrFNhf8jg9lglaW/kp/+UP05ZDEUtYvAU0KsgJdaa1eA7Eb3rjUOyJiZ8E
fnLPmpEVK7NJkM2a/THg5Ti1utyfGtT9zgGiwm5m2H8RZ7YHhVrnLnPCE4JDW3PgK8dKPIK4OfHf
d+h5JbD8IM6awRuo4zzAKtaeJirTJxXHcCel89YEz5o9qIMBdXD/eBPFGXizAXM3KlLHM+8pOsKG
oOR33LwfgVb8RSza/vmdAd1INENJTgDPFgcqa53WnON69Log/lZRwnHmf0pj+hyY1QZM+pV9avFh
qb2BSaUJRca/JEeOeYRi2Yk6bzLV6SWW6s9dE3+Tq7505XieHwI1ddyw1qwX5lSKfTo09VMgzcnB
kiPEt5zIiDNEGvPfZmdOqPaNTvmpYWFHnwruLox9FcHlZDxBmaIeB6oOGzd+2a8hLOKNo0knJgvI
QpbxQ1NIll03yeDFuhXDOCB16R2pg/0pCDS0vfr4HCCP9ZxGdnAOLSk6KCqo88HMyXSjzDoipYyK
AD0Vt6Vrcqqr2Dl2jtGeix59wDJR2qMumULXx/4YZrHkhk5HnsMk2z7DC7lJmd5HfQ/6tG+3eDBW
vg7kp/RakJEVo0/L2fuReS6nztrBq5KudAEWRZ/ivgleInpuSHf1dYZOufaZ0eJp387acMytaTyo
Ux27fTfMh24CHjo2fXtfD6F/b+Og9jUNrpNjBOYpnwx/l8tRysxbhWZsV+gbB/n9y8/vp/VP05oE
G/d4fWtqWU063zAGz59Ln/FVqYSaydriXnx/N7FCAMmjj1uEbvnaCnLQCK7l+AK9lSCOS5QZKsFi
OKaW3LvWCEnxn74ylOMBuIgaIeHMcj5IMRsNWYVw9MysV/eJbQ2PsFbNOz3U+oOVFKHbtggXDSkq
j39uGYopqijAyMGXLcr1Sa8I1R+8UDOW/ilSg8/xHELX2huIXcrq9Ni22qlsxq169vsnh4YLbJrw
3yJvw8D39Q6bWWdK9lDPXt+eiMBcaIHGZ8Ns7hXoIZFz3aI+E6nTtVcS9uAneS1EojBybc+iqTTl
cTR7Qzmc1ChC/wiFpuC5UlCZzLfoPVZXRwcEClxCFF65a2tTJzbc6GYPdgcks5wKHIcjadx0w9kp
k3WRAFCi7iqqTqY5b5ymldNLIZ1BJJFdU0ZcrHWkNgMYkb0d1OM03sWh19ff7f/KCFkWo95wni9h
fC3yvUU+9TO1yvZ7o2RulH4fzN9hb21ECitfjtU48I7BFA+uYREoMLhmKYPczB7jPmH9JMcXo/ss
J9MeWrDbd2ElyRE4TxbD7gt8rnr92UKYuE05dSYPITXg/+CND1Hoxsm+oQiBKudXmKp3tQow0nA3
TIt7tjifiCiRblD7ouK3BAmgQdO3KlLiHp3Wfk+Zrh32vEH2kdNiPDhjWO0kI6I4Z4SZO1kQJIVV
H22kHssupXj64EeiFGayB8TWC7+X6l09Nha/Ildd7av/QuXDNXeqa+9g8N04QGvf9a2tRe4RNF1o
V2iIeV00uzqiBlR1lHsD6TjemI0v+z6eBvpPbAdrF71BFnj9YWdlVMex0GWPussjDQB7IK4z+Duq
7UP7l1rWGxH1+0oOdRV8m4B4s6VLcBW197FIkDjwIiO9k8gaXrICteEyl7bAmu+3EUuoeKPfDVyD
T3e9NLMMy6YZfMVr0FxVn+3qV2/eyy3drCnY2MW1ReGsqRkS1dHKWUSsaq3VlpNGqpfbCP7ktR0i
OC1px65spW+378P7Z15jjPn1KaTNAFf69araSqmtwJg0L+7z8kC3B+roGf7W21beO0pwZkKiijSb
A7+cChmtPM/kQVa9rtc/qWGBUraDzsC8r1P9dNuU+MHX9xtTuBTmtMiyXhWv3kb7ZBamOSE34MGi
9kGTXUV+rGb5iMjfCaKFU03Vhmn3jZLU+w8mIIukdiRZoGqX0pi2oQ+JA3O5Z0Q+PKY0M6QhOvaQ
X25s5BJMiOPAkqDA5SEgFF5Ca/IaXas4Y3ml2Sqe0bff+5Zhvi43y2NWBB/QFwRDhGDlvreUwE2U
at7hfhBnmKunCmWxDX/6/vzQxAB+Q4+TyIZK4PX5odTXD5ova16Z5Ls6+635X25/z5UC9mubRMTQ
bDFwimsLthHU9twomtfoMhLNSqc1sJr48bnQJ/yX3Kj1l6iKhtwlzyCv0Yw6BUkMgg4loUjqxsPQ
taO0D1WjCJG4COF9cro227hIK906+GzJZ5gK1xjXWc5JONUYlvFoap5VotyRJql16pK6fygCp3In
BjlQHebUa5rf7ZXK/tlJ3bRxDFeumU6b0ICHg6olhd/rrRqMxOqGutNRm/ihdYJO65w72THz1Q2v
u3LJ4EMyCfEYjxYEhteGJl8LprhrdI8hTKAtPSKcqSWZSJilxcmQy/hQVmN6lNIWDvdR8zdetCUv
lLgFwqHo8NCIuGt5JgKpjGulH3WPgaUHvYh2sRx/mNrmPMrRQ5BAYKDd6dGPSEEonBQ/QJ+1zD70
c7dx+lfuPbAzwjLCGUZ9luAUyzfGjsqD7uGumRBRsp3lRA8Mkr/cvgRrH5YsTAzWorvEJbjebwce
zDpWS8NzYL12mvk0ITQ+9MFOjjYsra7ojaVFYKJGtV0EdmF4SV0DpvsaZdF9I/+4vZz3Tyn5JAPX
dGDowRDZXi+nLkuayO1oeIZOrdMYxmE/UiOBaAdOgY4Jt0np6v/iU0HhAuwZnbL3SFc99xveEdvw
xoHy7jBZQD/sVD+WbZUeby9v5WvRe6HTSGLLEOay5ZaGKDLwF90LyvKD6YCnC+VHo/5VQah929L7
cIuiHmOegF7oLJJWXm/kVEahU1SV4aWGeS9Z9yVa7qGcA2H9qdW/c3VjYStFDVFEBK70qg2J6Wt7
QO76smsnw8sMhBvdnshB5cgr00np5rHej1WI0gUMvH/ZWQ57eUtT8mRJOaP7k17BCDQok3GpFCeS
d73ZJ/M+NTQUEWzGAWHhMtrwl65mITh8Kx2KnRTM8uNkWaW502Ir+nl781ayEFZDBM6SiMEpPi9W
4ytmp0Wq4cnTXq2ineVPuxS985IhaFvex0rtlvJTB0h+GsYdK9/4eitZgPDV1Auxzj8si4W6RvQl
CjueFcR7vfA/Dikzbs1XLYwv7VdLvs+6Yde2xzRUtzB8a88VFVG+IzEzHnzZ/B+rBMAdzFCeOv6I
ZmMPbvB70nyAjZdWIVPnWrw31bFk/PzPAzSyKgrAAM6Jp5dosCwRswdGZXp+D9TGH4P+EGatdM57
Zz5TJCkOdm0jZi+VI6TpdLsOtz/7ioczKZkSGgrANdCW669eQV1MfNUTi0Jj7AZjkboGAOJ9FWnN
xjv1upZFMMrbAB0kFBNMsS0LBH44G9oUEq3Fc3yAttaNnW9V5D8lQDZ9bT+FDfOa3W4I+qNZvwS6
4BY/T/m5NC5l8DudTk4YIWw97hqKKLCnUkw5IlnuxNrd7U1ZOw6iikGdEhg1jE3CZb8pkvsW1SPN
TDVPV775iJFVjfOLTqRrq4+i5tCV/bEetXOTbBGCrmCxRIfxdeAYHQC2amF5LiQ7JnAiog3Oqhac
fLSidOMvuxz3fgos7FGu0rOeGCdLa12/O4cRErH5eKyN8JyG5sfbO7Fw3rwPIpK3BPnIqwrIIvdq
ZXBhGVHiYzmERwXdKmQ63FHSIEj9s1fwnaV30VprdsaE3kjYPddQWVRz+CuovwZRqO6kbvMsquzj
m7P4rzkw15AeCPTnMlbpnU4arFkLH3sYCGb7jL6y03xX5no3T903rbdfAkQPx+ovKaYPtPPT5xh6
obCe3GK23C5H5PzZhBxFs/ydbdE+2iLZWFzMdz9wsfN+3IVyzdDZY1ekzlFGxAwMN+oAOpDxDR8g
ztRyL8idqE6KST3ovq/PXCSPplKC+nlMi7R2O2g5d52u/+kwkjhKb60s7tTUm6HfGiNSK9GPpqu9
QfreTvp9pm7R4a0uh5SQV4TBjndg8zhtjAQBxvAxkV/CsnB7dYtTYu3b0CT/jwUIV5YbFs90yllK
K6W7xKnhenr+b7SywDkSzROeCX6nxVfpinaaQeKFDCk/B5N2LuRqL2nl+fYFX10Kr61KgYVSzhIO
VkRlrpWtj8wPR1/qv5Tz96HcKPav2mCWRxAA0+l1xJ+/8aaqWchmFJvhY5zTP4FTtTnx5G1EtMvw
4fXC2G+sLPZL02ZWWIXR46jmULa2usokYxAiThGUhyhWPVMr/6K5vW8C45vRtNnhf0g7s964jSUK
/yIC3JdXchZJHtmWY9mOXwjZlrnvO3/9/aiLG8+0iCGiCyR5iIApdnd1d3XVqXMCrR43vkKI5V99
hODkoxFoPl2A4WmG7sytUt2hq5E2H3CcBmIawR6u6S0q2VWbC0HOQkvlvGpl8mH/p6rGEt6iB45c
x+jas+7p6ofpDZcBpDX/GFrO1LN1NEazq3trOZLoLpK0JwPtUYSQ5mnYmMW1W+fckPDsihdlvH60
w1Ph/NX2QHmQGjG0O7vcEt5Z9cyl6WfZANzowkbmbnO0AbHOUy49BrG1r6dHKdriTF4dDcTCpMKA
hztiU1anVtpQS3F0itXfVjADVIIWKt3p7RaRpZgI+K/3Uat4AXLDLyks0NjlklU3UXTqNdOtpnZn
Z8dquM9/JCEQ5Pxm9OTYnZ2dDJTbidyt3t6V2QTdz1t2qfnzgBDMJ8TrEdEsA3UeW+0xRONv6ygR
I7NliBc2BNdQa7nNRwMb4ESPKK1Zd+Q39+WBZoabqWqOUvpLstX99UNy5UYh1b2gVCAxBo8mHC2d
pQ6IoQXRyYaANEYdiHh+qwq0OnkEWZiBQ5GO2svN5VtdKzV5Fp38zjgo6qOkJfva33rorI7kzIpQ
kaD6GbejlkenkGCysyqEDayNMH/NBGVsBFHA+NJQsPz97JQoqj4cZaeNTrN93+X1Iej/rYDO4gOQ
kC+pH/Iljkg/5vQh2cy8iU61/IWywDBCTazea3K6UZdaWxKOBvgVAavSHi9MVqT5TZhWBv5sPuvZ
J2l4bNOtME/IHb7487kNYc8UDW0EcapHJz2cyVEmWuWBXiiPyEbfZaX1NXaa5EG2q4chBpp73a23
xifspXaWK4kSRHRq7I9O/yU2/m6d39dNiBn6V+MTvGG2I2UcGzM6Se8axTwaN+YEvYYL5snVnrOp
ci3lqPOuR97PyrYmd+XkJQ//ZwGXCThzxVbVBrDGWnRKaHwiNVsZZPBkenJ+Xh/lqh3C55ceBqrS
Qqyul52dyKFBEPXNHJ+Gfq9Xn2X50xuMgJpE14wwB2To5WBQqjBjfbkUNYv33zHyFOsdbUH/nxFh
xsxcgb16trgQJ2fYG030yaxVWrDrRPOiUf+X1fz/egfoD7p7eYUpYpXASnQpq1QOVirLSAqBDGrv
0irfReqWK6wESVRGgWLQeb8ImwrH66jr6DTBeX+qFTpplAc4az0z6nb6WNNxtVF5WLuIL6wJJ4cy
+YBFY6zN9c76mkm1W6cPyuxSCgmbd12M8Nz4OBQcv9Y+SAJ3mrYAS6vnCk0l0MMuDLEiiDgfy8RX
LM5IKKSKPaANk/r2YLu13Ou7WnF8NyX3s6unZDgWftlsOOvq0XJmXjhanEpVWmWZbsmZ3C6yXF96
3JT6FVOWL+5DRRgmJDY5QA1hURHhsCW5q5cDmlyR9AFoAl56H2ffANy7Tv3VelSKW6KiHZrtG4+a
ZU8Lj+Ylb0eOBmAYVM7CTulkc1D6sItOXxDPccMIMsM+9IrknTVqB816wzvtwpwQghRxHGRpjTna
3VzDekjr5zn+cn3zry3a+ZCEx0ugS6OljtiAY6UonqLuYTI2Zm1tG56bEE5KWwrDquoXEzudgr66
r6Qbe3puthS+VuPEFxoJMjzU9EVeEt+n/QJiF+62sKPwGblF8Cko5V3cSb86uDDkHOBH3t+2yZYc
17ppOsLxiiUKEk2XQ6opxXKlZ2Wg3ZpzFrnO0I27SCntoyWnPUIfVX1EQ1Y5aXUzHM0sCzbmefXe
5V0D/Tt8e1CeCRMdSyl0yIrM+NWHwpyKQ9JVu7nXfmVRfa+xAJo03y7StFop71Pp2MOLmcsboNxV
hzr7CCGnJ7d1HUT6GJ0q5d6pa6rTDxCLXHfa1X1Ixzj0PcvLR+xKsY0m6dO2IICqlcTLfce8Ncwg
33d03NwmZae79TS9k41S37j0V10ZMROoPcjg0ztxeR+bg54VfYrhtkzlO6XXj7GizJ6dm2A1A8Pe
RdU43V4f7PqyGvTxUP1cWlDVS6MUmPs47SqOdUO676rHpCdJvC+oiigSwl2T19lf/ETfRzBukVXa
939f/4BlUK9OvQU1/oJreoXFGVrb78x+eaXE/j16gDsk0L3rJlad5syE4DR2HJkokfJEkZETKCso
ce81c0tNcdVr/hgR0151GNILGmIEivxvRKdx8hcytW7WRA999DNNN3xlLUDEOanvLryRlG0ulw3y
Ar2enJIxZXczemswl5JtDrONW3fVJWlroL8REDG68ZdmemUGCmLikghauK0TepbxHezuTom2993q
kKyFowxsBXlDwROVNK4nGrGZutH2aFfy2uJ3qU5741+T6C7PPfYYASILBjOQsNGcIS1bwGbRqYCy
aPR/hdNB7Q628W5Ofe/WsUsPQfeozV2KdT4Rlpn3h2H69QavPPsI4brPW4vLRGHjxfFTCLd8G93N
WyXYVackS7QkASjFvWB/zp4rmV2GchtxNjuEZ4Z9M8YKcMuPQXiwyoM//3jLiP5YE5wlgAzTqGre
6QBaK+ANWaO4Zfhw3cjqeXE2JDGkyPU0iVLWrqVma/rf4UV3r1vYmrTl72eTRmW2TIqGScs7rzU/
BZm/D8OlL2/0nC/gwzZOJxGA9d+Y82xEwvHUjRb9LD4Y2B6VOXX8kIDrjJsPRXS7lIK66G6BYLqG
/Ck2sqOhddADtpC8HYZkS6V8Y27FQyUxlWFppiaXk8ZebD1Ab7oxt6tHMZzRlEEdgA5iKmeeJSe0
0olTMup+N501386m8S0ftWJDwnT1MDkzJOyuaqiMkS4sDq7kSckSL80JqWHP8Dcp3rYsCV6v+LVe
DxGW8tm4qdSCVpKHxC93efF03S9XV+dsSILn23nelVo7cGDMAahY8xne5S3f31ofwfcnPRuKusPG
bD1mobbPmx9K8m/VUF+O37OBCA6/AI61UMbNbBYl8X+PwRsvE8gMyB5Td0dJ7XITI37TZPqIo2VK
ehzy2ZWy3/DXndpow9HWZ+yPIWH5tSCHaCBgxqzKfJdpz/YEFwukK9fXfvUeptVJBxtEJ+VLFHd2
JpXtYBWTSvA9Bob1bmmZcGHpK9wYmvI6jZR3dqDEGwfT+sj+2Fz88cxmkVZDLxvY7PonWZn2eFw5
lhtGVg9bh7zrgmdHck4wUspByMt+5lVR/E5SzTX7Gz167mXaSQ5jLt9en8a1IS1N34DHDEh1RK/I
27iLndEh1x/m8rEqQIyUfjwcm6RIN0y9FGHEwJYCNdQupO+QAxAyNg3g1E5X/Og0BPNN48AEyqWV
pPsGeDZEzk57WB6RQwJEpZ9gpHowrO6vttOBA7ZeIsmJO7fT8fr4184qA2jnS/P7Qp90uaSq3c9O
kfBNUTTuCOWU/HfewrO3RRW5dlRBTwDoalGD1UTk1xBPZTvaaXxKg09T8Jsi2PVxrHnN+e8LR2Ec
+mSepCw+FfnRzkCvgWdKgq+wPXgQutDntrtub/UFTrPeouZJXwu6B5cTFyaGXs3tMiBnqA51BUvZ
nJgQk46FdQO9GJxGqROgn5M4bhmM2TdayfWNj1hzXmBOwODhX6WnXjw2raQtDJNBK8EXNZA9SmHS
lozI2sLRgEHfzMLtB4L0cpxJPnftrBbxKU+zx4bXvitP1RbIfu0w40gG2EweAfiWdmmkiipkSmli
O1VNrnudHPaeDBoIjqfyZ1P2XNaOuaUYsOYxSxsLcT9w91c01eSF60kupviEsH3QPPZG6iXF34oP
63J2PznFxnm9rIW4+ZEmAJ/AawYZKeF5FoGrG8kTxSc7tr6Umqt2f8fqzZjfRKP/USk/8v7c8I5V
iwvdAsBx2j1FSESh0awqpWZ86ps9MU9h57xbJsi/9YCUqeUG1fitMuzDxsZ4Pa/0YMNPDyx+afcS
K1qNUWYltBUUKn5aBz3dVdk7JfW6H/4zGZpR8ZzxVE1HffB6+a5H2MBsvBB4C73TGzP+2nP5EJ5T
EDWCwQLudulUQzhlaRlU4cmZTh1tKZtEP+qrJcXAotCw6KWSnxG8dgrlCqBpBwho4MnRRrv5Rqr9
j7R238rG4zA+T3npDXXlaZL/fuq2OjFXJ5rKJMrXlA9BlF6OryotcwrnJjxx17gBgjcDFfleqb12
3+p/U1fcmM/XmxRdK+KIhY6VdLTI2JVaZV7nXRaeKqvxov57A1ywH36iBUer9/G6F63ZMhDAAKKL
kAJYg8uxpaWUhbRxUIjqy72a/TV/lqz5JElupv/r/CE9ycqiGbQQrsGveWnJ6UIrTAoCAEn/ncQE
Uemdgi7s9eG83opgPDk94ZhROWrE8y1TWgkOHVJBbUR5JHusRjpinibzScqf1a8wUF43t+IZmFuU
YZd2/1dbsM7U0WgmahbFkFIVkXaa/1X3D2pyaxcOAdWv6+ZWaiTL8P7YWzbKWVwogUiJ8oZnvmLC
rOErXl8at2loHW2l/6I1AYKnv+f2u3SbRq27ldFYyVdeWhe2YR3a42BPpE2kULqx7NEtZv/gW+Vd
E93FiX/vdMa+Ke0bf2gPqlzsyt7weANs7I6VgIDPWApEC8kGcP3Fpc8mwZJ9mjiWzIrpjLdqq3q6
/H2Kv0xpdGzSxkOmY+oC5Am37s7XQQCbEnpkMtNLWVik3/UzWQmcIuWYQ5fQhjKGEg517i0XXklK
QH0L2BHuZ6rDrPfl+EjXRsZEe9Fpnn7Jx1DeleHkJXrohTpw/cx9NG7N49zfwBVRNBvFzpXjYBHC
4apeGFThib20vRwQ1YSGxMmxfiojpOLx57p+duKPcfxzw5eXk+XynmYNz0wJMZVNq6JNKyH1hOEp
np4L432UFa4ZfLLmo25Cqn8oiq8bNlcuknObYpZFny2lpJjCfk0at3kfGjdR8S72j+OPtv4UGrrL
P7pDBu24YXhtsJSQyLqQ9OSRLcxr4NdM98jWCdOT3j/L1VPy3MiaFyQd5HCfdTs4ZNLWY//1kwN0
oq4RdC0i4zwGLhfTL5S6m0bex2O9XxK7yF54BVUNNd84BldK5JeWhNjVTppZDZY8WjZ3Xhx/lpqv
ea3ueXJpzs9a8Qop9Sb5XViGH1U1O4bOJ38a/zXAh29YcEpL/wPIPOEmGxt/jiERIZcnSYpXSwN9
CBYAEVOLC29jOdeOgoVABPQ0hzEiw5czO/nNHGbKFJ3osfB0rb1Jyw9BRikXfi09cXX7i6KXXmr5
O0vP9kuVUE2TE8R1+1r1H69/zMqVx7j/fIsw96bax1pXUJfLSRmWueP6zlNiocpnWu7cZW4cRt5m
dntrApa/n53BThj0y3OeM1hJHp3S3g25dbCH5zcMDSlvVFOA0fFqubTSlKbRTanDdp2Vm9o+ap0D
iYm5s/X6ObZ3s655yFPcXDe6Es3yNKK8s8jjsnuEOKXI+86UQ4XcS0qbRF/qkpdp2laD1NrePLci
XGJqIQV2NZB8UaX02IbqTVc9aAOJhy0cwKohhPwMm4BoIcu8nMNsNPrO7yTcg0TaHjhfeSwM67fO
BjwoTWBvRHmrs0fWAXUdmh/J91yaa2d0qasCQjt1AiEzP0zFVmPq6oAoUi1qBQYdH4LrJV0DklLi
DM8qx9OMe4W2KilAMm0ju7gWZ9Dq/MeQMHPdJOUzYqwEW6FxsrJwX4WqF4/9LVWCndL0phvN40F2
4p+kHf6+7oRbgxTcY9RoDW+Xe9icb6C5rNKPi0YcwtwbwdTqcvGugheFOjAte5fLZUPlHfoGnTPE
Ux7NOlo276+PZCVEprdi6SJ+ifpFUhINcc6UVhE6H9R8R5HUJ1I2lW9pGx1Kys3WuHHVLssvhhX0
ciisG/+xxMc48qcJ/5vOAajeJsQk5xta8a4PacuE4BiTpPUQHGFiaj/F/Yi+V+qqmzrAqy5wNhBh
aTQjl1UJjdXT8LtgCJb1QDvHXD5dH8vyK9emSwhMSoLdsZ0Zy6jWbpJW+2p8l4zvx7jzaHW/bmtr
RELElzk5BWFg5aeubO7teLorwuex+qrG9ac3GIKpjiwriC707C+9ukukXkGylNBSnnZ69UWBBKSR
d2NQbwQCq55wZki4oIBx1UawPDcbpSQ2V5YXoGN895FN37iVVtcJLhNgUA68gWKyvs4gbM0T1ilr
I2/S7hKqhJ/bmLKaXoS/r0/f6pY9s7WM+uxyVwCOjnMMLgTdgfnDkPvyEWrFD3AoPdeNFR3zbPph
ynOxsXNX3QNKTgRvCFhf9SwrqIPpYQcIwZLbYm8F9IoUuf9XriMDWoXxuLGLV48+ujNpFYZT9BVX
YzPL9G0bmIOQLXKNIuGyp+dtw+fXPITMNe3ydIDCAivsL9j/S6ss0/9C/djDrfawfYpvGRE2VpQg
ImIvKJtEuWuN2i2cexPO1+tesTZfS+MEmT5SOARGl17hlxXYfIdcR2Np1V9KX6GBIMXFxgN0pXYD
z8eZGcH54qDT2ykfuXUdp7hBCFYDa5d+T+s4O6SpE4MqVqZdUM/dfnQ6c++ribzrfSnc5aZp7vs5
ydwhNbUbBSJlgt85uIMLcLN1ZYljxHPz/DMXZz7bI2Ogmv8FAcFtXiD/FDftfoQTZ9AMmGvvOv+d
5iQer712M8e1vtqAtjQkQWgRE2ZIqfzUcSIqWs3ezPf2dMgfr6/02llDpu4fA8LYNCOVtWgmy0TA
8w6Iob2v9XxvGX1Geif8oM/Rxs5fDbWW+BQpS1gliEYuZ3OYKNkFE9GwUZbOvuykYpfBC+xK+ZDs
E7VO3KqDxhzOqNIt26L8uzaKrSzz6rRyEhDxQdvIqXD5DWk8mF3oq9xOynd6J524dsPkx/WZXTtZ
ydbTngnIGD0XYQ/lQaIOqp9QBLR2iJRWWgO19yHLv4NYCJqtAHbVR8+sCbOqOIUp5xpnT6TKB8v3
5GkiUp4eKALtoVY6SPX3TJsIyrq9rTa314e6elxAQgAHnIJ8rqjY4ihRGeY6Z1LeH2sbCta3HEdn
vy8Mzu8n9obE749+tlPUwp2jreB4OTZf7fEzE4JHSCiBTNbADaFXwyFRo4OqvGum7iaWPxfaF4TS
NoPX1Z13ZnH5+9mp0hpDLGkoUJ9i/Wc6SrbrQBhSJsmumcLnWDlcX6JVjz+zJtxNmSyp9jDjjTHg
5bmqPyyXRhfUb0jMLCJ2EGCTlWFrXQ7KV+weUVLOK2pjVfwjju/e0hHCrUFS2IRKSKMgJiR/uBiS
rp44suZwh5nPuQ3Nw+dR33C6lb5kJDh1IOiLuKpJ4HA5lg4YRRrKJLrSuHvXQj0cZ59nE8Bua0IT
pUMGOECnEJKiiLrjlNlbyeG1JSORR/UWznKqm8KSKWYFofXAa95Qf6cgnSiidJi+7hcrpxS/zlIR
tVBXE09jTcsiOS8wUveU1LTGLbtjGms7kha7Iizc4V/qiADDA91OxMdzHskMci+XswpsZLJ8hao0
EDgvhjRel7lRVXkfTM4Xw4juOvmutbbKtsv2FbY3SFe68gHUo5grBjS1ZNZVZ1bxqUa1inSZ9LmJ
kvtWqvxdLltbrMkrK7coltPDw14AniEkRgo9GVN9TF5wGRBBuaUCSfjD9YVbOT4ubKjCPMY5TQB+
HJ9aCpST7t8l1uTCCDx0X+rI3l03tuolS50CejCKIWKV0h8IFbWgj0/6/FLHz1q3MvTwoPpyeijk
4UmqgoL3vfl83e7qRJ7ZFe7QVrfT2YYl7SS1nh7cy/ZTs0UosmaCYUE/RVnvNXtSwRtLdtIhPjmD
fR/47Tsy5v240dWxckHyItABQ1NUoWNOGEdj9p3sBBixVFA6z4W11UG+5t80F9DwCvMMqpvLKM8u
k1FpDBokrfi0RIlQNEQHEwRm7n+6vh5rTnduRrglGy33ebiBfojSI4xDB9W+VW+iOtvp8bfrltY8
7tyScDuSdkM4GN3CkzUdpL7O3VSWv41GRbFPcXN7n2r/vqVxEVL7M4XCwZTrVBFQ14hPmvNkWPdm
tO8rKL3+JdfZy/l3bkZ4vyEW1TZEi/EpUG71QXeJf09Lsif5klS1m5b1Rmy26t9/hiWWSuJeM1rL
1/DvmSqt5TdeY+s3cpf9vr5ga9cl80chkcYl0nEiEG9ODCfJJR9kTA5Cy8r+VjX1Vh6QmS3an1V/
6OXn+tkISQnOBcJN162vugvIBjCokIQDOrj0/9rva7/RJJBqNiC/psx3ppLThh+nCNzQrDaf6vDn
/2dSyAcppePPAxIMp0FRPqQdsQjMs0oMk0fT3OppuQ+D4g1n/oLf+N8ohWNk7vS87NUkOSVm7JWh
GRzqTCvcYlAktw7Tm2zokw2Tq+5DNLc81OGyEeuK5Zw2Wr2AiNV031Fmj0lPNuZGIWHVCD3YS3MU
Pb4iZfcoNSWNKpRh9O4JzGbYPW6WLVcdhGfn0v8EYZIp7O60DOO0l3nxRQOE+RPNZfIPH/E2CVij
eqNuUnsuV7wYcChn9oRtnkhFmOcV9soofgiqwZ3LO3u+V6DTVZu9jChFpt0m6d/l1vt6dS7/GBbb
6hypkiFy0EhYK7e5To+iae8p/n+87vzrVoAWLlcm+02YTrvN/CYaTbA35MOt4q5Oa6injteNrN2a
MC3DGG9AS8K/l5saykErajOMxAsLd52+63X/6bqJtXG88KcvjRLULgQTphoOZF0wgXoDRANPuvMo
bQGHVm1AoAQUny9+VazODai8jSgi4m3vJDr9sql2Y7Lv10eyFgGAN/7HyuKQZxGAHfRw1ZgB53z9
kGvzfmwDV8nuDMnYuFBEvZOXG+zcknDWmmPqB1nRclGGQY3SDVr0I0Cym7YLxz1ajPUu0FrrQZbs
FNrazPwYq+lDMwx/W4MVLmSY47FQAsjNdbvYhVNUufLcze4YypGX1vZX2wxosy/orG+0wLmt4oj+
vigNj9bYdqcW6D7k8jyEkGzbYllZXyrUhYDJU+8XMSN+qUFFQ/75NMeoOabtnsgdaYSNy+oFPSQe
DjzqUJdAkUwF+3e5VmiA8h6DAPtkpAfgzneOhoieni19IOZ+UuNHNf1L1RfUMyiv+iE04y9KXHm9
+VHLf3RIbM5DcdsM7x35NrMfANUfZPUxkFTPyPdt+l6KYAvCqQ/XPWwtXastQSxy3ZTKiSkuPzuL
YZiQYYc+meW7eMgeoh5071zcGuhYy9N8mlCOaDMw4jn8qW4fznu96I5V07iFFe2gAkegWN371SR7
179sddnOPkzYxYlmxmVjANk2u9Eb49KF7Ff3b/4/I8tHnG0wZ4wdLdXAbDdp5ElfqvE5tzeyJ6sH
Hp3JoLUXuiKxYbKqpgp/qYkNx0+xE3vyFmPx6iFxZkAYQ9hUzSRFGBjSnUp/eeCq6l9J8OX6TK29
ElC5+mcYy1eczVQR90XexDy2R/s27++G8Q5Oh/R93G445Nqdfm5HeCPUaErhTBxEqvHeknYj6GtH
29WSQ93gFx54fVRriWvwwBADADtiA4ir06E7ZhkVXkYopKmzN1j0z44ZgKdPTbODyfsdj/xe2now
LIfBq8PizKywZoUvKcU8kDCpQyhlqXES0LrlPHpKaLmN5njmqKAlXG1h61dX8cyusIrRENlpsiQx
NP+DDPKJgSk0xCGrXhNRX5/bVVt0WC9NPAs5o3B5TQ2dJpPBSvbWXdomvpsodOWn/U3jRyR8twRb
lyl7NaVn5oQbLLaMqNfR2To5wRN1JYgGHovs4fqQVt9DNEJY0JTy6gdPfrkLUM3SjWKkN0H1R9NT
yvButj1lfvLpuM5gcQnaY5lJX+LpmNfx43Xj6/P5j23xHsvnKuvHAdtD+tGfmptWbzyQQG5pPzvR
W7JdZwNVhcULe6kuSoueD4lXEM8SuPM7YLMPeTJnb8DlIhgBl9LS8USlVbiCdCUs6mIgEfWuNCpP
LaejLY8btZTVyTuzIdwmcwe7YDYoHPRyB2217U3Zk4me2WDHLuW+6yu16opnxpa/n52VbIepqCYy
Q5lVflUQh/MN65fsmLvrZtYPL7qf4VRZ6PdtYTebXRW0YU1LWqnV7mSkH+Cuf1dmd31R3ErJ/L7M
70rHy35smF3W/tVOoz/UNBYKUeAMl8MbOzm3shmzld/sitjysvIRjq22/zyW6Gn1hatRAjzO1Rbm
bvUqpUpAgpl3Je1kl4YlAhjEA4nkVCWzPCsax9vBl7dIwLesCMPzFfqca3WxAl+tJ1nltPMTjq/r
s7jqIyBBgBKT3iA4vRwLqM8uHWsuHrRTnW7vdJ2X/Us14v8G9Wc2BD/UK7obspFHihaH6pKbN7w5
lbnkUBMf6Un6P4ckuGNLns00G4akoQk4PCm7JNlqeV1+4pXrgRvkccqd/YoKPOlGI9QmTMiWN2q/
DYjK2s9xnh2vL86aCyyJePB01LQtW3C0Ccm6aBi4S9J2BqpwO4X6/rqFteU/tyA4mRrEWqKqDa8F
62fRgHjwP1TVZnSzPg6IGRfRIbiXhetKikYplQau+7q5oxN5DHZ2nOwo7e50XmOTN6b3SnYjyfUh
Dz5l+fvcrzd8Yu3cpcWN4hA0pBDlCG4+JXMf1jMLpuPgBp1mbtfp+w7ttDwyd7ORPL5hXs/siS6f
OqicZtiTMvuW3nVP68p7qZg23g1rrTS07qESgqCTQtgo1CurII3SbOTh0CFpWlv3zoCqZ3VHUg0m
wB4iRQjxM95vWr6TRujJP3fa7i0j/fMFgo9GsVwiJcoX2PmXrjYOc+Z4drzFybvqQWfjFPy0SKJk
tFqsmMYhslxb3riXV/fB2e8Ld79WzjUwg2Ue6/d0/3NHDlK+4YPrYwCTBm2GQZJD8MFe7SUjaXni
2r72IwxM2wtLZX7TcvwxIjheDCtD7i+NuSSEokq9s42frZ9vuN36bP0xIpywidHkaNYvMW5U3viB
vStH5WYTcb5q5QUlBj0jfAjLE+0sfLH7Ki5smdivMCtYPzoo9JoecstZkrLDdSdePR5oqgesCBac
2O/SVKkU5RTEmAoVc299k6bEHYsbYwj2+pvmDsAVzqYDPBcpfdOwMEhrzUuNWvby4PsCO2+yjaT3
2v20oLr+Z0TYlJreovAjE/k5amS6yjzExxA9n4OmZzncYNoWInd1/lBuhdgX4UgyxJfzFyFSjKaQ
jGubkkICso09OmjCg6Qk9S53dEom0ZBtZGZeyvniLUyn9D9WhWtFD7NybmvKT3NT36nN7KGpfZwU
qK2KfD/3zq019Tv1Se+dwxg5v+gOeW8ZwcmMP85JfKdJDwtaaWGUue5Mq35LDyz1BvCnipi/BgpQ
qbNjE3aTfUusY60Hnk3F9P+zIgzeSJtmMiqHG03mrUel1Hk0p60s+aofgTOA+gLc/atk4hDkckak
m5wK1d7B/ujLUK85E2rQGw67Pmf/M2SLu8Iv6EyaJCl+yZUnvX4nW61bZMVbTsd/xgMs5dJPeUTK
cdMzntJB2ypwbkw92aWbFMOLu79yzDMzwm2lN7G0AF9gR/DVAwXZj7TNO3HkdWim0jBIz8cbri9o
JeF7gK2AVlbh+sr8JJalhP0eyu/HT4jRpG9x6nMLwuVVDkOIRiTHVjj8Fc7PU79Ipb7BpekeAbyj
LnJdYv+/WpSJDdk1wWge34SFfkOfdWyEGz6wtjhgM+l+JnBfyB0EH5CsJuiSODlFzeTCQ71PQABQ
zVCk3JOQgozjjcVZOxwN3gi8UhUIyvXF98/uMY1uX23224T+H2RXcxRlfwVzZHl21dte6SAtoPrK
W05kcF3okSztOHCVXxr1x9Sx+yFLTrr+rcwPXKZH6YsRelFdHq8fRKvzeWZJ8AxjyOsxD+rk5PfD
YelBDf1DbffQV3DmOdUQ3Mjaljeu2+T5RScaDfoiCU5fDWqhzUNy6iow0xRmi2PZaunt7CQ9aNtR
3vN430dJbG5k0VdzHdDW/GNZOHanwh/LHHrR01RPtPgqAYjiCZ0sxR0UD3RY6KoOKtvxD5DdG/fd
2hlJcLLkMCGGoun5cknzlNZYtTASVA6Sr2M+Tbf6lHyLJjPYOIxXB0nfnQPRiqmAeRAHWYV2kUZE
qtpQ7gufkDv0+qQ4GD8azXzXl1+ywdk19q/rjrS2T86sihQS6uTbfaYTuhbKfYimbymBNP5rDO4A
am5M5dq9dm5KuAeyQYUMc6kiZEBGGiBtVX3fRAFFwcfrYxKlu15yH+eWhKtAYkxysqCz6sLNo3Rf
RQCMxuwZgFvik6Gy+kMip64+UYf0h29ddozHu2J4mov+/bC1VZetKN5L6IDQzERZnfqgEOZ2VpBZ
YUHq1qzLHfpWY1Yero93zUfPLQgTG1Eag0wGC3CO7rrE2jOxmw+Ddf+kD5AyIbHmqyYm2beIKaOR
GDo0jikd6YVMMxExp+/vhrl3C21U3bbr3knpVsv2qpOemRY2oV0rUeHPvBTq9KBwfgej62Q15PGt
N5ib1DzLgrxesD8DFe4q28oMQnni6tB5BL/qmUF0aJsEBV9VPjb6cRghtHTkD20sbdzFq65CsyWV
Uw2yv1cAYT+21MBYoF3Bk+3/DoKNjbG6A89+XzhiyghVmqQGEYf+TVnXH6z8aITFHnbojYGsG4L2
lnEslXfhIoynxBnTiYy7rhb7MZ0RrFOOc36QwONf9/1V1yACgzFqYYsT8R6GHhNZLui7NpO9pZBr
2+E+aux9pRm7eqsFZHWnnVkTHDHUmoQCJRMoOfe+DfIDLn1zg0Z7de4IXSgxoRvEyC5vnFl18qaH
2/Skx3+18k7TvscwtGx4wvIjr3z8HyPUDy6N2CjrhCX6hounSdCQw4SsmvBMPFMRvJG02E2R2Ly+
Ums8E3AVUu/GJ+gtF9uVYz8PazS5SfeMnwfjo6TVu4WKHID3QZtjF86YEVk/q9wbhWZ5YetlebUv
4bq8K7N/rwSFW0IEQzsAqgGKCK/1pVhJ2oZvQUfYbefovng5ySAQtN9SuDg3JRwn5TR0SZfwZozl
8NjItdsoykY0uLoJePXCCcfT9xVYEj7rcDBHXlhac6+G9g4ae7cyEbGNYneT6m7VGPhBWgxotiIm
unQdx+56qS0xVjfhl9G8a/X6IAXdUYI3qUQ/5rrXrO64F9oefBKyDvXSmsZd3SY00pDTffCtxKvz
uxThuutGVs9d5BZBwgOKBHF9aaQeyiYxrCihP1f6bsTW9FGGMmBDm3xtXxOZ0PhBRxVE9YIf0HJe
GYlWJid5zt04uydN1QJ5oiUj7zZMrU0apH3A300QcGTYLsfTOLNfxjGvA/1OQVvh+xYVz5oLnP/+
8lI4e1wNRlZK8VAlJ0vZybN2zNNwZ6fTXUlaDemxw/XVWR8NGVzbBHDHe+7SmlOlvZF3nFWjbLpZ
MaO57Hh9vvW8WQ1wLLJH/7MjuFouT4EETIHCT3qCyNoN4RO1mq8VyDb4Dg+KXbtj+dwkWwfjqmOQ
Q5BBqFEIl4UDv0/TrGxDziKgNc0Az1/1Ncx+pXO8uz6Pa16OXO7/7LyM/2zV6l4qWiPgIMqzD3X0
odkSL11dJzrkYVGE+QCgyeU62UkAGD3ijQ+DYZnUe9qbQmdL2W7V9c6MCK7dh1Ql0MQGMZ1TmQUU
lP6lJGYD6v5uaLdUM15ed+I1CQ3rP0MSHN3P8mHopuWso1GX2kRoQLwceMrfZXM0C/U0zfaHVP7L
TGcvGB7CFoRjU93SBTuH6i4Kvmf1Q9bdAityFIKTTzTFdkuObayMT9fXdu0+p4sHXU0NSiNUnC7n
PsoV32x05j5PPUf6rprS3mh/IayLGM8tD6zgLTDyc4PCzNhDo0dmB3Jdrv1d65S7BUeeTxtgitXV
PhuWsDUopFljJGOl7Z5zpESk/5D2ZT1u40zXv4iA9uVWkmXZctvt3tLJjZD0JNr3Xb/+O+wH38Sm
BRM97yADzFzEJRaLxWIt56SeYL6oiZNVPKbL1dNBwY0VGfiGSMdfa1BG3yqZZrjnQQ8+zNQb2unj
/h6tno8LCfQLLs5fEkxiZ9TIYoxVualQ/gfgYGUnnRpv7gtadSgYb9QAbYgcETvnGOWtEbcScl9m
8iNABjQd92MAaC9exmJ1dy7kMAdeKOMxVAmuGeTcp2EEiY8/xT4ghLZVM2zmDDTZvyLpte8Le558
c6we9CQ8g0HCK+YJtZ6Wo2De9zCHoKkBAN5pUDAwmqPEG1X9uSStVdf9NuxiXhvf6nYisEO6D50C
CGuvtzPFgIpGhhJHzsRMSr1vhsUaeVAFazk32mGOrCLSQribroWAEdgcl2lJ0SowvteRcpbj1kXF
VCsdZOHcBP30nFhoDaZSNoD+jsoDFgfkrmuRS4pxcA1IDIfQkO2ReEO+D0C+raOEX/taWTqKAtg7
zKL1tqZ//7rlIgwzUKRDhuHm7VOO5pyTrIBs8kiWYWeWAGbIersQeMRwa2fkr6SbBxA4S1vSCNg9
can3UUFcsA+MpvqIl4v1f1kTpl6u9YmUV6drGiSZWQdcifmERsEHkve2gPI6Z/PWbPJyVYxNmmma
xxEBWl28ZBZovRvjcSp+/of1fCaAMWOJ1jNWhohsVp7jlHXjVlEiP2wf0rK2s6XlxCurXfXGhST5
WnNqQ0goSAPO82zYSD2ZaDvfmIFDMJ8otto/4Tg/oI9qa+b545xIdq4XZz0rHylUn7gIXvuz7bPX
NBncMBRRdtC36fg9GhdvFlrTwkDvLiLdYqE5GE9AgRfWrR8kYBmqOpiawSHDuMexCDNwguDzi3F5
TVQZlCTbZv4Qjcg2VLslqd+rylHNDT8KOwvT3Bz/vGriOmq1AB6i6WvGHfZlX41gFMFhQqlqKyaG
thvKXH6TF7E+NuQ/UDgDrFKnAOgY8MU0ODXOi/sN/ERTAuIgGB/KpI4i9JrbFRgsBuyz5N23wdVY
HZOJABsBzh8IoxkjHLQZ9XQCWWXwOJBqu+hGaZdZ9YxE/l4w5lcjbDZaMLhy3j7el70WKFyKZqyy
i7qpmmsxPWTA6LABrIJutEHiZY1XT7KhI1lH39jQ67UyJXQ6ItZD3UEFaDZOMqqY/IrOmoUgY4Be
JuSnTVww10KWAHS2bRkgvC263aIXuyhtvLTvWwtNZZxE3Zra0OQBgChQMiMNxEQ/ZSq3tV4QPOSl
9FlH+lgq24TjateUdimDsUCpI4UWjXQ9IbC3p4duKRxuTLqqNBpagfhVwHw2I8SocylXAVlxmLrJ
zcIfFUomUdy7CWCxv25p5oUkZntmwGL0amBAkvwHLDaWMPy5L2BVXxcCGCOraiVII9BPHWJhi3Sc
laI7hhvC8PTFxBNADk8CgBDgviAPcoYkUfMwD4CYLtz/sBi0f2CcA9gX6MO5NmZ1BPeeUGExmJcr
0V2AGQBuEWTViC9kMOEYuq7SOYtgxGCpH1pwj4HN/f4qVrWlo7saZ0QEfxwjYWg7TMzlaXao03LT
tN22k8912m1CjK/fl7QGVY23DjDxPwc+MRR5rTBMy4V1YfZwMW08WlKEgI6gn8ER1QGsK70Upv4Q
BgJwsBriKEH3Ls/BQw+2OV8d0tgpBWAe6+poNQbR/tz/thXDvPo0xjB1Mk0JWN7wuhwaG+NGXaZZ
XMCNdQXQVnKa9QM5COOSSDjk/dSjYwTY4E6I1ockfB2JVcuhVQZvKDVr057og6WElR1ryC9gSE6w
Iuk/tGCg5ItnBCINEbC1TIQY6+Ig6CWyDHpD3I5szFSy5fL16yq9FMLcmHMRGp+1kgMlyY1l0BIZ
qdXpPADeFfvFJCEgAzD6g2tZYXYui6YYMQJaIEiiO+D7BYKJQ2DKwCb9+kkBlg/yHbQFF+8wZveC
XG0bjUASvgPktZET9ZULJm4VMGP3VUe/mckCKSbm2DFoAUKsG1JxMEfJHenwnkZGHGOPnbLXCww6
LKT9jsxRaQ9xFXIO59oBuBTJuAGz0vJOFZGNQJOvVQXzU6YkTpiIzv2Vre0WHZMGtiGFkmLDqLQR
w2IRZ+zWKI3WABZlrx68qD+pasbjwV5dErrZ0I8DfgdkJ67dDWUeqsME/lmZX4G5rb7walorzhkj
lghAKfYd3mmMALEYsl7F+Pohi7TCKlRJtSez4b2PV5ZxJYUxcCGrwOaLpgLETO7UT1ZK2Q4nHpLi
qhTsCmajwOwBxr9rZYEOsgaFbZIdQJAedcsTKvpGV3MiWXojMnatguv9XyHMUqQsinMDZNaHutTH
DTp7noHuoTpR0hlWrJTZpiO94SRLwnlBri8OuW4K9g6iOSaCTqK+R6MosuyCOMWOULegzR1HR++/
/gDC+v7KYTxERsww1sDSeyiqxDOLt0gfLbOcbH3gPEdWHAQEoYGSDlGju405rWNTA1axabIDaGi8
AABEjqQcpUzyBiICWTaNdveP7aoCMaHyyWwNvgdGnmz2TaQ3BfApc8nFw9ghIIXMdI55rI2HA9xI
gb+mXXv4j2sjBMTGImUtljVieASlkdDqsmyjp8JDhJnwuQ+Oo/FrTPT3sAvsbtlHGvpqANCSvgCs
HBAgr0bBW/mKw7r6JGblqhmpAfInGWVFGPAkSsEMhXuM8pjfV/Hqlv5dO9sXJZaDMc9Dmx2G4HUK
FE9sR6S7SruY3LwvOfazlioAxBNIdTGNT+Nx5rhHUttBtVV2KGfSvfV5luzqUUT/FzrSbJLnxdmo
jP6pAGTXZknSxAGz8U+ADSXneijM9/tLX7UuDSw/FLgf9SLm2GhgfSmTBdYFIMwXItS4gHQB3HAh
5/JZa9PCYxCgakgXgIBLYjbTWKRuMQl0HCzZaCEZ1sPxqEVjKdUZVAsu2oa3gdJvB1AFBMJWSf/k
KAKnz2l2niKOsa8t+uJb2C4teRnSbJJgWEmLVx3aEqKp3HBniNes6lIKE+nRkQsQuGGfhfQbKS1F
sUBWLqvfeVXztV6LS9XKTLRXTnmE3HyNQqbVg+qq2f6uWnuWLDmz5me9svrA+cODXlk7m5eLY9y6
Ird5KxtwF0Ilb3JUAfKktev8FQVOTkC2el7Q7oCMOHW7wNW+9kxdopkhEbBbQ33WWwc1UzikRd2L
yU5qnYg8E32TinYyPN8/Gmt5JzwY/gpm9FrJI+7TeIRepwAwZvux3yyyVU6u1n0WBNHVZQ11xjkp
q8Z5IZXRbNU3WRgZPdxDolkEHb6UYJj7HlqVAghdHZk6zFHIjFLDNp/bYYHNZAAWC1vgl4587JzV
E4BCN9pvBDREsowCmK4ljZbizAOoN5KbbYqXTgssJZBpZrx2urWJfdzHQOijPWgiqnrXZoKu/ZwM
SpEfDKXfdJK4Q5eMFy5upz0DaSUYh01Yb9T6R9L9hw1DAyrecsCVQNMT1cJFKjRG/B7qcZsfguo4
hii9jYaV8YSsqZJKoMPmtKGEEaI2Yq61upkfGl37px+FF3BAulMuvVTo35rAjXTf9ultfxUtwlGj
e4tCtYKwEBPr12uaJ2SaSRJOPtA1UbIkguhGiH9b0Q9lZRu2E0eHa/KwNFwylDgUmK3X8owctKHT
OI2+1JvlR6HHjQ2XFzpgokvcoVB/onxleGWCEaT7C701G6wUYPF4EGFCG9wazEqFWgumRhhHv+sx
tpSrUfo0pdq3WFlMr0jTkyDX//SdIB3kIhkOEViGdqZcSBwnd7O9+Ar4NoyH0+Ny00M5FkAr7kg0
+XkvIx/7oyhUKzPrrVn5Agr999d847vxfkbjk4qnNOBUgZJ7rexmUNMqTHVs7nQEQcYmVdQHNMR4
caFxzOj21qdNUGgdQJsaHp03ebqsCKN01iGqe1f24wOxdTt+DV/TB+UxOZJ981r+an/NT19eH4Qi
Y4scCzLEN9c7Waa8AeudP6Pfbx5L2zTSjURSK494HSorqoTTwZwh7iYcfvadOy+t0QOEdPYnjEWY
9R5kcBQvtkjf7i+JbglzHjFNg0kByjRJ2/6ut0zPS02ck372peRbWL+DkeP+768dAyATov2SYsYI
N97TpBAFcmrMftnELtHfEnCDon/NTsriYGTggykQ5Ve6vUjv6MLe3pe+tjo09dIAFBkePOqvVycL
/ZKVsTn5eOwDXyXM0Q6a1Twc8pW9AnYrEoBIdiInwYa63STGTdqhOaEV1I3WCecmFh7KtkmsBqmr
+yta8WcAjkFeDKYhgmSJfsvFnSBJC1Bc2hDq1KrB6QYw2Q7ViEnNUsp/xXosHADogqJl3n6ZxgL4
kkiK42GB9jn0tdMvu5AcLXo8z7k6+RW4zCKxo+ZYfxnykQoBYgK8FrIvONfXQgSZlGImRbMvAC6j
rVUbQiSJkzlY3S/ATOO1jcsIMN7XQmYQw8hpH89+n/1O084S8TgxR9vY3N+qFddL2a9kQ/nsQmAz
SaUUKk0P+hk/0z504qqoimXZXjHRXT7w2kioITPHGEeLPrMUHWAgbNVUlUkXxF28+CgsbPMqfBmW
fD/LfxJBsiXJFpvXXpvO99d3E+lhr2QVbagoLaInhoXsnsaC1PgUuGAtsQLlXBiZg1wJx+DXtAh3
i/FuOlh4AwJqoucoKmN99is0yKRkU7Xy72yujn2l+2NWcPZsxWHQsiJg1j4hQVmYzFJQmiZtlsUv
4r75beRZP1joyzO+fpEAABwYIGh8wCAAi43UTplWJoo6+3HUKk6lmfAZsiqfhhTevhQ7iTMNsOY1
KMI5/kWFACWCa4uXO2U0A11efLHIPaHy5Yh8DI3V6Knb1osLlGhO9LNij4gFaFYOoEJYJeOm2qQ3
QfodCf6idptIXDYFhmdr+U1rt7m0mRQH1SmOyJVTDZFocwLQtQYXxYjs+qQlwCIExWQduZ2Zb8gE
xMHfcs3R5YpBAmIUQ9WAJEEgoNFjceEH50VHEkvrBT9oRfBLzonyowRyt1tpkbElmZKdhCWot/fP
2soG0jII2pYpfzrqFIxQTY3bQpcWP57ORtu7QeanomqZgYpnY2QBGuC+vDVlXspjDKbCG1xRgRfq
q7GVb5Zg0225c0priryUITFrmjOjCUpl8Qd1p2fnsRs3prTVsoeqyzjqW3FV6IKg9R10ZutIjV2L
KlRVL8o5n330UW1Ji67ifNg0Y8AZF17RGp5Q8Ia07Q3SGK11U90Vs1LN/jyJiRUHzRnjrEk/+F3F
q22uifqkygEijoGAm7HCPE2buMgL3GGVnXbpK1HAc6q2kmMAJuG+Lawp71IUc7BKfZbkXoSoTH0S
U9HCzRIsHIe4Ygvo10MZTsUuUZiV6w1S8XwTumSafa0vLVE5KR/9gH4IQNPx8oUrHh6uHQUDCl6N
65KxOuCQgssxhesFqqtF0GEqLb/v6+s2vYMnI4IzTPPj0qL9j9eLIeDyFCdFxGLC6lzGj0HoYbi6
EnbN+D/0+Fjfp8LLfalru4ShKPg+ShgosKEubBIcDJGEK0UlswUKdE+W09gKw/7r1z7Gi1GmwH4B
Qos9S4mcyOGoY3UwhzCogXCJl7zJG4JfV6IKEfTxCjnMkTW0sZk1gn0C66Uzkz9p8HN041Nh97uB
HGdel8yKg0XJheIkI/lIOUGu96wLkZDTSbb46HBwQgHNqrlFgACSSPtmnveRTDb392vlAFPAB8oL
h5kr9AFdCwyEcomytlp8Bfzx4LkuX+MIDRMBpn/dapE+7ku7RZvC3Ds63AyKBQLDZIdCTSmM9H5q
F7+ulXEv6+CZnVA1tPV0HL0KI1MgC0lqKwbDu5/Gk+zJQlycND3TGiuezc5P84VHt7VyFFF6RxCE
tmcAVLBTWZIIciWp6xBs9ZGAGBXQtkNd8aZIVw4GpMCCAE9BC8fMaUT6uAjDul/8cS+c5394KHwr
kQ6ADCiiIBgE8Zygnu0iHOgEI1SEckRoFQAvJsBc0ZORfWR6CmDBTMCcR5fu5KnknPYVf2lSWFS8
ObFLN2P+pIcr0fQZqtMmK2gLZ5iBvoaroF2cfvnFMR56bzGvi0tpbBlrbHoJ6EMDbHWvv9dvE6Aw
XMOZ343eLncST9qqRpHTwR84GXjSa40GUw0bbqHRRu/8ShI8TBB6daC9zP1Hlp3U4BVTTQ/gTdMX
p678WthIGNKvcwR9oZ2rT7kQCV4s8yhf1w4sUpc6eilxb8D7XX9WtGgLJmphR7L8pEgPyZhYynJM
vo6NqYuI8ugQJib9gX3LXFChAVgkSYUn0sZXxXzWUbOvs4ey+aOK3VsSK7ZhngJtT4KvvyEhGOU6
BevTkDRkLDkEcTtFMsYut79qc7BChLfGYGvq7+ZHpFoRMAbv29XtRqOJAwVL3JJAgrqZMJkFYMaD
3QRBplAc4SNRgO2xg9WhlzBuMe6SShydTJ05D4Vbh0DF0g4SGgigKn29kaMJ2GS9gyvUsm9E3nbm
8xJz3O3tbULbU+BrARpDqxSMKps+w3xZBBFAs5rn2JlHGYgjbyYIsYWhdIMv9/nCZmipFUOHSHIp
bODZ61lLVAXuQMgkySsVVH7xgol+iFXM6Ya4Led/igJ4C5LJYHK7eWbNizLhKln86qOoi21OeqdX
2kPTTVZXRw6oRtw2LDBgFflTexy7+pwvgD3J7LIPB5T7R1vJRM6OrhkSDNbAeUETHv653tEUySSR
Ior5Yv4dMyfW7PaoiUpeGx46JBq/HA/jXYsjii502vbCpkyXsDa0BOS3flAeR/KH8q/xWLxub8Zr
EcyCUH5pglQRoeTx27D8kr/+HsIwEKZyUILEpN8NPh/YM7QCtN+Cjw50F4hLOHpR/0b0mJP9XTsH
qHTCaSJliRF5xpd1PSj00jDGmxzdzdq2R5/JrmqO0zbUzvd9ye2FiBVdSJKvTWAxQC0n15AkRZKV
iL0LflQHs0f+HEZOYHIMjrcu5i5QkD0U5wHSErL/LXV2KNvqvKnI9v6i1jwVGswwrYy8hoQS4PWi
mlnN1c6gZlAkTpBVToXy3zRzWWnoNlzf71AesJiQN6EVFYXxiFOlNohhkF0gcBlabI1yD9rcuQD5
Ru2M0T+F2TyLU3Ua03ArE6DucGFm6fbc+wLG4HF2iwDhDK6CLnFJ1B6o1zRDcz+nLl4xmdC9AdXI
jQMHKPtpZ08Cr+V0VdcyGIVxE1GaSkbXQd8q49BBB0J1NNBrUKpgl/vqRD18J6azdYQRyMKhDHq9
nyoZsqobkPHQxp/F8oSZJ24Cfc1zYB/RzQB7QdWFOQejUHSgQjERpTiD17zet8fbEAjff/HjjNnn
itSGi4Ef78g+LZ+q6GHRMK+5uS9l9SgDR47iFiLDxpZTpBDlyioOENs2XlDaKvHH0koaux/d+4LW
rg28X7HndF4XLbnX2yFQxsmugiDUdR5ItJyyIP2N2f43WfKCYHgBeqUOFiNO/nDN0JDmwLGGv6L1
omupCcmGdBRSwa/S1k6aByKdQK/OcVCrS7sQwuwUcIfQR6Mmgj8N5lsV9ptyGlxAE9iVIdlGKoGs
QXfzMuU4rDW/iHccrVyi5xSru15bDBLnqBxr+PvmRdMfNeC3y8oJmk0SvBeab/f3b02TGNtCeQWl
PZSdGachZdUMY4U0s5veWxL6ZGoPoF7b3RezZvWXYphFFWbU1XVUCX5cbNTBzhM/KZDPfrsvZW3H
0CjwP9osNEgwPjg0U2CSglPND71MPEq1pc3usAmIU2zDyLova1Vx9LmKyij63tmOlrlWNMDw4fpS
JeSOoxD8dN9MXC/3pazqDX3hAloPUH1lO0vMvqhbjEYIvhF7M6a0Bvmko9I2pJys69pqAFcDEB6k
i0yMSV4bXRPIYdK0A4IZOAklAiIkFCYmv76+mkspjLE1hZzXfTQK/nju298iRRreSl+e28EFgcga
73pkQgGczBzbGO2bQ1YKgj9L+3nedoId9Nu45yhszcHCwFCXwcweiqBUoRcpC4Ldr+ZZFjA5eiyw
BqVv7Sm0zWHe8CuT9JOZm51ynYOnDR4PBRrqMi6EFZOEBNdEBn8BBqnfgTnGSgA7+Xx/d24xNlCT
kTDvhGsDlgAw42sx+HahSeZg8Ovcr/X3sXCDEjiEB0P6TsS3pnaCZD//Vh4Bp5wXfgyoj2w+GM8x
2UceOI2V1Aps5ZfcO23GuWVWMpnXn8aoW5jb1pwwReqXP4dd5jwt29n9LhzU7/dVsJLiu5ZDz+OF
ppPULAIjgpwOSAXLwxgmllw6urkp5F0EPM/vY3pWZC965fqTz8DldpP/ap+5SVNsvTwOEN2Uu1jY
ycFWLZB6tiRxr7ZennxTAGr/TsBMNAdukNvxS0keKxdQNQ0BCdTToiHbGh5Sb1E2kvm7k7aNdmiW
hxB/ubQkN3pNnqrQKrraa8kezN6kWayg4DisT0iLe8tgbNXQx6GRB3PwW8y9x3vw7xiBaEnjaydq
VopKi65bCfJNfeQuox2BsfehzUs3JE9xsk3RQZ6UO2N6V6top/hq+C7Wj0XhqEphdZWCiTgnW1Jb
7UFU+5qQP+0YWjFQJRLO3f9Zgby3DHrVXBiCFk26WU/h6CvFI4qDEwAjQQathR4Fn1mswS5fo4/c
anZ64Czwl31hpSe1tDXsQu1n6JGJvFg/EjsNv82GAzTuboicNHkrBbvW/O4Un6dduJc2ChDewDwC
pVnYlmYv5s+lWz6SyZbmk3I2zHOevKbkOAHn2hqfp7datOL0NBy11Cola8LYn3QQgpOZO0C7MSOO
IlZ6j3Ai0NkEhgUwp2HQ+1oR1WyQdkLKwQdiFlr+5rzdaE297PK6BK73VEh+UgJuOZS1Uzbn40ve
9kCinGbeoPkn7Mv1jkgi3p/IQSsIzUFTdP0hYjbU/TDGo7/AXNCDaYvq8DIg343Mqr00nW/8rkEd
36CRoqzFTWZqG1nYmfMPsOdayShvJtWakWPpLAJwwmxMN8AY82iyN4tSqxaAZEvsbttrjWfQzD7m
ZI3c71rNE3jAgty1MEqV+lKqKzNCXyPZgwVGf1c9gmNRnmQ/TDdTaKAHdzNNHrB0Y7Co5hGyxShN
lrtUPCUnWbcU4sWbeNiWqR1IzlD+U7rRHglGXT6XvYXrwuJxU95GIlA/us8Q7KDYgsvoWv0g4RlG
WctH/4eye5Qfv+x3r3+dUUgsR3hUZvj1oFuwF42bS9vOQN96adNqBhGP5rBsujn/3suHtgrxaIp4
udvPwfcbC8N0DUhS8KBB/H29RCNpEiHvkxEdJfOJCOQReGBgAI4ey1TdF8D7rqQGzctwYyUKBrPk
CLUdBNm2lMyn3lieo2H+QP7uIWoMkGoP7cNQBx6qNk8g9cSm2rEoOyFmF4lrgjCiWMZNJ7uy4ev9
01igHVrX7JBwzu/qtqETDGOTkommHOZCqwR5yDOjGP0mydEDmThlPqDYsQlQ87i/h58Pkxv1XYhi
LKRqRKVuwmZE7KA9NWGBoV30rJTaGaggr7IaO1lB0PetO4I8Pwxj9j6klVM8ddHvrO0soM14gyFY
vfxzbPZyrtiSOm2l3ON85W0sBUujHQYIclAYZRmfgnAwyjZaRh/cMbo7k8EtCrF18lDTnIKAJ68k
wRE94/D5KShyCBjfO2VIHNLOplVnhWgvLVFw8PrerdFQ4iqAoThEYQHwiakoNnFtWPCSOfIsi4Yn
Y6e5raR0T/eXcUv+gElRFOLA/kXdMzAjrm0Vgw9A5DDb0S8B+qhLAH3sgRNKSnWnLMO2VXeGsZ3m
nwqxzegBPAmuYVqFCIRycd5ViGTG9KdU89hXbt9f4HXBACuGuAGygn6z64+S0B5LVTv6oxE8Fea2
K89iqLh9m3toS60HP1p4RJUr2wmRmAOlpUnKv3Etcqoxb2ymAkSmjb0ke8BHciKa1UXJ1D2hoQ1v
C/laQtXpI+kydL8XCACiaNtJR13K7HbYZqg59/ty5vRlUy0x5wg9lX8FMm4II5KFWpYQOE4bObZA
jTep21ndDLwTu3K3Y7+QU6YwDajKsb3YjUmmMZugPFH3kjLxEGM9qMdQOLYfzduQBW7IIyejfvx2
bX8lMi/AIDOCfAkhMU488CZ+oN98B1aA+4djVQjl2QIcGCr2BmMTfaikgMQXR9+oAiuff5gBceP8
SY6GXZ//GHiFgFUDuRDHGEih5EtVRlhTthsfBM02Tu2OJFaxbzmGseLLARn5d12MYcySMtfpDEED
aIzLHNHoPzo5AKTLva+/ldcWJaH+K4h5bfVtpuW6AR8pv+fb/nfwPbflPwrmO62WU9xYN8ELUcz9
lElLhxlyiEoem0dZsMimd3NHc5s9LhCdc5R5CmT804K8a6VPEAa86CeM8Y8noEhwdEd3+8bCLxbE
RDKJjNqC3lDdnaLHobO6X8O33on2gtvv0NDWf+PIoyfmnjzmIkgjtWlLxBJ+52I4oH7Nt/JWOIAM
fKeio5gH9XCbJ7qyDLZuV9STWSr6PKLG4A39sZ1gi7wmgbW77dL82OaFeOg7MxZwfnuwnMd27hWR
VSzO4kuFDbuIrMgnW8MVLEcfNtEPzilbXSJsDrUcNIJjCBgKv3j5kSkuChLA/WIaYZ+18PQgAS54
g4QrmQZo8kIMY4tmkucxITjMob/ITvm7K50JmYbBBY2IGYX2XMPzRxvgW9mcEIi3QMZCdSKJSUKv
TCXdGGDGUrfGMvOOwepRQ0YZ1TAATWEI+lqLVd6HSTdIeC4UO/ANH2S/zCzNTk5NZ2m9Ve6yjTBY
5Kw0nIB33aPQmTGBDnEDkORacgd0lRT4ITBRZEMGafH6d1MtN3rhG+kI1FdMHVXfgZlmj0rA8S+f
PefsYaQANphwpNMl7Bs1W7q26gIV11sdnZVs22rf9GzYKsVhEU6qDNDZ8FejWEoCNCzpQYzBABn6
fbsdm5eZfpz5XTDdUPG+DhKr034bdDWi55D2hjJeIojLARCxGQZP4qdq/EOWH/P4xvFEa3b1V8ZN
k1gixRGlI5v85KBqHrD13MyPjpo1eYCbOmvP1riTt/dlroqkwSbQv9AmwuIGCaTQw0rEsubpZysd
p3Kr6Of7ItaCCTTh/yuCfsKFO9DlQap7TGD5watiL15nmcdpH/FCsbUY4lIKY7QqQKXw+EgnuLxn
3UwtLSHbJUPDi7ZthF3beVwwsE+SbNZWUbfA0wE5fw3oI9cLk6oxL4AqMfkAy9iUXrhBeUE/1g/q
3rQbb9hPe/0x/rW42jY8ybv7Sl3zDpeyGe+g54WhLkuBmbLtgOoJpvP22ut9EbeD99TkUfWnHUTg
gWLraDkSQKLSQkbjoN/aM3bxtvPSrW5XW+WJuLlrcEoCNPy6UeiFQCYOzIVUmboKAkd7snjIR6sa
u/hxJvZr5XzUky6HxvIRI+71SZx+RWQ4Ygc5Z+qz++jeOhiLn5pgDqYB6yDPbv1UvbSb8CcwlnaD
ZewWL97XTrrXdvVu2mae9J4c9e/BcfbbR05ouHq20VYDAFrAm2Jaj7HPJFA6KcWKVaB7HzOiWmLF
4yRdvYUxX4OGLwOiBLZ8baAfsZLpnplu/No9K3tjA8BpLz40x3bXDy7HJumlfqPaC3HM1SsnWlqW
RYUpxz+tZz53OHmyG29Ev/LGx/E9OmY/n5H/5Vz4q7ZzIZVx/mmxZLFmUsMEXP+4Qbukndcvac9J
4nHEfL4qLjxlLkxFX2oQMxgeaZ6H5bQox5mXmV9LM6Et498t+7z/L8QA6B3zPXoJMbWX546xrXZa
bVmFA7YNR9y3z4q1AEDxUd3Utnwe9uLe+L/pk41t5rAEtFpfQ5/auzBto0i00mYCjC0nnFg9AZ8Q
rhiAQMMJVfjFSjEtKphl201+vWzRRIo69swbSF31WRcimCg01wHAGyDB709mgu7UowhVcmye+vJb
m6dAtP9bBWPzZVwNyWxgFfl5rK3iuypZWfFQDE/omvutCZgaRcc8R6hE69X3hDImr+mhJmYd1oXs
eWjJv5bD/NPYNh5Q8Fz9QfhAwKt9JN5e/o7nBKksHkTDLS4KvX3+VewNz63S9VNqtg0+YD61lrZv
be0fpbLaEckcC5PvP3seQPl9a0FG7Npa5rYZhLiCngEJYZBtHG/ajnPDrbsvmCJ4xHHIWGrXPCSa
0qhwXwYmOrS3PHyuH4E1bHFr+KtBPE7xv5KY/ROCemyDFkcsfRv3QMN1pR2olr3KBk7Jf3LKCL50
zMdSEGPmognaJRK0vodDkZyTPFgLeOnex+PyzQwt7aDvx3+03g4+Sgcv3SLkPVfW8gWAzflXOnPI
wyAqFHByImrObZC4lH9MpPx24e9UspBlNJ7rf9qCW8xZfahcSmXOPWgwpXpAyw/61FHZNMODIDty
u0tOkyzYRtZYxnwuzF2YfYu0X2YUWWbqBuMu7j7SsPgWFq/JNBy7WfZm3hAR3dmbk3uhD8Zd1ADf
KpWK7kbzTZEIcJI2i25JH0V8DjM7/W8v1UtVMKZWxsDkXsQBphZs5NoRcSvX9g5leFyXqPRYhXeo
cid+MXf/xTH+XSmbSxEDJVkW8Hr7Sb3LHps5xCjdN61xw+GlEf+psx+DiJDLOHfcXoP12PhCNOMr
emJiUCrB9gvn4EE7tzbQ3O1qMzqGVTvTvrEkjudYvWcuBDIBf2eqQhyMwuSHRik6NZkwlRgQmZO6
WY1ALqQwEXgsidksJSOWlXiNZIl4W5jpXuG+dKl67tgoWyhU5zJNw566WiBH7KThey6celGxksCS
K42W5UtykueBc6tR078nlnFUiHkUYc6wPOAmpbZ5DFzDmzur/nbfMNcuEsxkg4AFRRUNgyXXF0ke
NFGSdcvklzMoF6ftUCFq5MHArArBuAqG94BwBUnXQiYCkvKklfFyl/ZmJdp1d5ZU3nAMTwjj5aIS
cCpqIOGJK7+FvWEJ2q4rnu5ra82y1YuFMP4qqZQhbCXIMILnIPlFQPR2X8CaQ7wUwGzH2IyYkxAh
AP1VIDrswb1TbbR6h0GRqcSwGudCWl0PclcYcEQRHEOL1xuTVK3YiyXEVTti86AhVjfk4seZDZki
NUnLHj+eeigJvhPOC+RzYps9IXRY6P9/PLMZNBs5TTV+X3rIrfN0mkBPZNXn5Kd4Dl86+w/+x72/
O6uu9FIkuz2GYYydLuIFGb8CBwiNecG+02u7z1XHaIEQ1f4G3FkxP1d1gxZBAeiqTW/N4XfOd1DV
MUvHGApdOJJ8Jma9r/etCUKlS3QFByqLc90eVLn6aRhxtE+kOQs3SqZqsxWPAprKxEzIn4OoUoBe
kYjitEsb3fQGzClnDlFqIQUsW27s1f9H2pXtxq0r2y8SIGrWq4ZWu7vt2EnsJH4RnMTWTM3j199F
H5yTbppoIrnA3k8BXE2qWCxWrVrLpMtpMN0xAUyskeH4Rb+XzZTiayHWfJiBcnKnVIaZuXWPMWE6
Vsqvum3LCLL0q09jMz3amy4bBhEaZdEGqlIYcuIbnou2qBkY3/Gimh61+cXtb9rGwLvnd2N8uf49
BJ7O5sjxAmBVfgjKXX6OCdos5VzCUrHoRmC0qbXPta728TBwJV4vWBS4u8CaDsJbvH35L5/ojTIa
KlC10H5R2wLznNsJolyxcrta1dfryxJcQQC7AkyCUgkbY+C8fXU7I4bIMYD3k/oNlVdArdw7NpKn
13dqvgUg0ni4blFwp2PEClKAjHVCd3li7AmdIoy3ExWTDG6yq7bCDRyI292MoIDroW8S/YM5tpEo
KGNsln/bp9Sh9UyBHnZBmamjSaIMRlSozmtid7LrSfDhMJfEZll0jLB/YF3NnAqaanNJjkYdgzy4
89Nl8wtMslvG9rUbZC0n0bcjINIDYETF5CIPBWqb1LYGANrBpbTtsnU/9J0bZLkSOol96G36vbXI
69/vJiN4wU4CVw6CUO4U2ImqxpWjHos3vdLfqqGF3MQvoplv/2AHnwygE4JZeL7WO2SdDUXbkRwr
yBMU6wsG1Qfi9X0ruRwFpxqhAy9fEAMThoa8XA/RWpMWwwSixTr9brvNbt7MAPSnEicUNeAxPYzx
WnA26HiVcpdw3Re9BUASOWpKsz2YZjUEFV5hO7KQJXTcyQ7XZehfHTdXQJM7JTeT6chYHwXeySSC
GRmWyeheuLt01IolydArPDqApw7FtCudZuckye3gamFa/L7+BUUv/gtzXGQhRlobkK8gRztX/QZN
ycZuA2P5iRDqlkVk4QKyjMRfqLVLIUT690kWrIPnHxBHYBt5GttlJXFLwcd6rEnt2TGuvC2OZtcB
XPq2aaJSNX6XSiMZghUcSNzX4LphczcQ5OFeYY6h9z12H15L069Q1KXf6KTfKOrX2ix3utVIhqZE
H9QErhEEFjBo8uffITSN3QmAXRA7BTQHuDxuTllb7Ko+gaCqGUsK+KLlIXHFlC8TGVJ5Flut2DS1
tirtmKT+pqITCjhg0t5OCZiju1MOAMt1FxKuDzIqGAsDETu6sJeHc1jX0arRcz7W2+gx4mP3ZJbZ
vgIqu9Jk5FyCawkTOf8zxhe7rW1enNbuteM4YfZnIi0GmvCorbIsvR8mmZ6iICkH9ShGHjFxbIGA
VbtcWmqVWmEbrYZpDNCN4U0DwDzECILrGyi2AioMeCUueT7qqEUfj3bRacd+HgC9zKw3i2aVLLaJ
Yii8j6URTEuRBxJjeGUbB2PEZ+qcqfG6Id/uqdqt9yhF9SHebKg0VWaYNFD5bWKo2yk1OMnzBVJy
6YJLOU1a/dCom+XhapHJ9gk4UYGmRDsZjIMaeND4qOdky9a12qwd03QDtxuKcKkbFZZ7MxMaVOUx
NquXMRuPffegOhFtbS/ZnroqgnIdGMwkRAEijwbFou2YSCWhisN5NOAheaWYCBCA2o/9i1uBDbOO
YkjEW4XElOjbA1nvEAAXcGh5zaY02cy+1hRyBAnCuC/ga35ZYFz5uoeJINYW+nk4oO9PtPcH3FlL
o6RdU01jAherIMpQb5qxn+N02psLtjdzqPp5wzMmqJ3kWx3jO5uYFoswSn0DfayvlmGNN6MzL7tu
tUlIMFK4W7Qt8bt50n0DfxkjrjGmdChkkpyh1HbrHNdBH5MydBxMKLn6Zu0nszE9SlsSDLPyZOpF
dZNOJMa2qt/7cTF2xVjJBJlFodCxkHmBmBPITj6Jbe26mObN0I5tnKf70VHjo9E0xS8j7X/MFfpl
FumcYCk7XZIYCQ2ju8nmcwHDMTkPSgtXr4fE1Y6bAkwdOLBpSndN332yQSmsJ+uhLonk5SPyJEBx
MUzIRjHBhXIZqxSQPi6pUerHFBmvl2SHpceIw3U/EmYLIAbBFfmePPMJX2saDWPkRfil0drv2ih9
6n+4G/jiPJTrf0qrIqJGMRgk/xjkVgVBMzJqMQwC4OcBzk9+grK4fLG+YLJef0nuEz0YY6/eSdbJ
/iz3qsfHAxkJMltY50EaRlPYpJts7ThDXTENyk/FrXWajJ06euTOjNyn8b6TsZmLShqQfHUMRB1k
H4iFl1+wp8aygPgCh3QcfUzB5ZAYm0NT/ebk4XLAeI2L595Tripemb9h3kmyZtHV6uL2wQAv+jGA
U12aX+oYqcMca0dFcTaMgBjdt7hs7c03IJFzU9XNvJtUawvRCAZOOVHaXZvY9aFODCcw3fYLVaCP
YpGhCOeMdqdeOigpusGQQIEjBoTyjMHt8gdmrqJampLrR9I42+caE0+hpg9mVOuzDIwhOr9/TH3g
2SnWlbp6mejACIZWlvqWceNqMQYv6xskBSetlqQAor4ldEP/uzY8MS7XNher1WkF1jYazWFtp9u1
Unez0t7h0bbLUcBotCPRy51irX46t34nE7UVrvidUYDJ6rg83B6jRxPu50xHXcipQYfTf29UNdDs
7bmxwDOcb0lEMynkVOBzrJ5hApnOKHAM9snP7iVLjRclyfFQzfRDsThRbCa+sWp37vZ7+JY8tAPa
Y8ttYjdHzXaCDT+ktedoBQex/PgJ3AvnHZcwchBQhvEz33HixjTdUBaw2RSJ+TXulWObWX4WltPd
Oqqe1qgHtfmUWPuu+mzR+D5xntU4kVwdguSDiZ4i6wD7PUY3uC1J7aQvdWMmjKIHXxrhJw7XLcaM
6WsBXpjrh56/NFBoQUqIGg9IgYA754GTtpqis5dt+WmxwFZh/nCzp+sG2EV3Hkh5A9yZ3TqdUHdZ
81PcP43OGs3tcqOjxtn+6gznx6I/la4MhMB/R94kd/eSXHWdZoJJWj4a2SHJJy8rdcnGfSgVvFux
UalHtmoit+A+ExLZmuSVAytNXofo21hhAZ561FnSzlPdYdjFGd28RF2KIDOUOJoI5gb/YXMhJICa
BSo9H4JGZc3tnKaQb8yaF/1bcVeH6gKl8MLr9c13/haR+Z8Vg4wITF14XfKUh5OqY54uxopXw/xU
mCPYfFYAK/bmRA/F/aIOo+RGEjonstb/GuTuQ9BMpp0OgMwJOlcJsEUt6p7/sIGoAOK0A4AAGdDL
8FNkDTELByqbOrKKvHyBJjnpffrTKkKU3n3FNP/JoMkAwRABRlp6aTBvcijO62Z+ss3ULxvjlONx
buRlmFSKn5vQjA5TVFuur/JD1vb+5dBTQtaGhWLO8tJqO0BwLofoxCkd5jJoK5L59tJYwaiVcQSa
Cxfq3/oWKCVYIEGHutfstfu8gg9d4q+ik4nqPwHXAaoToAm7/B06dYesGPE7Kg+QwsTXvl1f6AcI
JVvouQHuUCa6MpOlxve0Ij2oXpJwjsj3am/v0l+D6kVfax+v2fVkRuln09d1rw2Lu/ymAD7oUymp
wggDxPlvYVff2dVmq5hhyFP8FjP1rIjUakj0t8mcd1X30I3PJD6lpSTYfsgi+PVzH3rZJoXGBBt8
u5Ze8/1264IVs6BZMN8PPcJCyv67vueiQ4pyKXJWE8OdoGm/XOYcu4OxqCWGtgvbS9s3zfpx3cCH
tPg/i/pjgTukdafoVsE2cvTT3XIzBmjCk5Oe7bJDtndDfd/HoHmVDbNJzKLxcrmwYVXHzumL4tTg
eWvQF20OAXAYpx+0nm6W4ZNWesnyBEhOUkK+SVXDXsYLJ/6cIAFgY8QIGTw7jNH2uGIGaKBaQ/Na
TLTx7JXsSgxnK8PyqbTLKGkCM818JQFfoHbQqGz6Xxg6mMwieErxBTSeInbNy6VJejs/KSR9ophl
tnLExk3xK0vba53qqxpm3ikYrnJltxj/Ei/PzXPeVU6oxAwot59M1/WNuPFbs/W03yQ1fFX31S7Q
7VxyswuD1NmKOXfDjI7ZLg27VMcXmtkB1OFxi8sGddhf4fMi9GbQE9XAtI3Z3UvvyuhQqyh+56dk
K71BnUKSgtT9u548q/WpMtudbnSSUpMwIqGSiXENUPRoSPMvbRaFW5hpryIi2T1ShO/D4oIZ4zuA
WAGUWfy4u43n7aGaZsn9IwoROhpuBoOTo7nC2bVTjHJA76g4JYXlOUuUgSbheoxgsZTfTQMPCca5
C35Lvr88zWTtCwVBqHFvdcyAVtnTuLTe8re5OQtF53a4Vxo4yodUSSjUzw1AHCBb4uuljsRZG3Gt
4Ib19ArjRNfXxj/MeJva5VcbtqZTnaYuTluxc0Bg/Nupn8dA62ZGdfAPX4rRMNgY3mWcpFzMSyB3
pM55h1BbvykxeLxMSS9EdLgYgzf7ToxhlluMuyydYm8Qkt6+5P2tAlXVbOglG/YBhPy+Y+DLZjIo
6BbyfOi5CtJsF5X705AN2j6LnTVYs3oIqDspfq9AoXadEyVcaOb6OiSTAxtdS78zW9PTnK55Bsnd
Q+E6QZ3EsQ/JXJYtrV24oHDu41FY+S4qA5KdF20MkiLkhPjVaBZxG1OMeppnqoLUaFj8ogeNgGdN
lmRnhEZYhgRefwSC99Gks5REwUDSlBXQN9wyr6l2dHk2hvvr3io667iwcAYBPGe0MZfemo0xMAUp
xKFL0gEI+EZrWc1AdB4sPK8QOvGJP4yOLH3fQJyFiTQihVbw9kAbze+tW4Rr9E69ZpaETeGmndnj
riCD4v3qrBCDTbSHrjJ2Uz37TSHJ3ESLQubPZMzeSQG5g5ei+EI1G6KQOWhO1gIhBbozprqELjhZ
RlAEGL1sOkX0pc5Ncl/KnJS+zieIlTbJS7LMgerUEp8W5i/nJjindtXSHLoYWqFjO9mR1c2an6np
fHTbFtUkvOz8rh62qFFRRlSyxtpRHe5SpSVB5cdVZSMsshXrl75ZbqUy2iZWnOK1xyivpAKiolud
aQehcKyyi5350tkBM53ZQM8Bqqxg4MD1EwckR924PimmL9NrEbklUkKAFdBiQAeGe14MlhOX1QQh
XXM6atoDGVNPUx6vH2bRtcqke8BMByJwwuNt2Yx7FxP2/WrXnyi6gfrNSNxAesaE+4ZLxwLkASPE
fPQbO71ZJ2pAOFeFmt6yRYb6nJvPKTUPcVoHaDsB+SB7/AvdE9cESASRN7CpkcuvhQk4RWmIjXIu
ONPU2Xyo6exnpXGo9a8zaI/09VsFeICN6a06BbDLbWWPJ/Ye4/MWoGegGcNqv8AjXP4CXENTTLaY
rRttzwnH0LM2mvvD4hxWG4hTqCNc/6SCQAPhMwBcoCakfUSXbMZcA2RaFadO2fy2PNpNMBmfVnC7
WeVzJrvuBetjevA4Eia+LRTlLtcX07FNZ8hKnVLtpBXf6PKre2nqu00WPkV2bEikmsA8QAaAJ2os
aGFPIOyCTjs9GvGpsMxPYC58NMfNg5zOy/UtFL2JkFiAJRboCiDyeIwhqrCOPTFrvV1p3jYRkFv3
axMWXe56XeF+LSHRdJhLe/BrkKr5amrMUVF2MlSl4HhaTBkKTJhQffuAFGob0qE7VlUnpWv9qfm1
jYGDbHSUdYYEpxMakyD7AS8uk8LkvHQgdUGXpYHMroEi5zx4vYMxVN31yeYZxistZOm88HP+Mci/
e+e6p21KmME2yOqwML3tmzoc0E6WfEnRaYDXIMQBDM+UlS79E2c9nroYO9iDhCfztLfmPjaCIfUB
Kyg/Jyg1fNui5Q204qa/L/NgkWRLwi94Zp+7IJs8q5bMhP3cwttB/aI0WUAgXwFshiT1E60UJII4
9dD2Qixn/352M+kJmW06mRDQjiFcnO+KXMN4k5Xu5hqSvjmgwGD0kR0UdqFy4Q1sVGgvYHANJGg8
TYBGlTRx4qE62WTO75Ze/UFiqzjFbpy63lzWje80RQVBOMe8G5OtiTQQGz4uBU0DN5+3sNEJHt/X
v7ng3gQMSwPRKtCtAGVyn9yYY6o5cVGdaDJVuw0qiX6WIiDZE1hOrpsSuTGS1PfgBxwJ4aJfVzRd
nuZuebK3V6tbD5N6mAM85qJJcSVh/QN+Bnkj7hBIEgC2gqSAB9I1RM/IBFW1E+m6+W5K7TiMQdUL
OhPApACFy/Y1rZ0wixGPVjKPXoFbIlzmsQnLuetDMtMpSEsAbxfwA+zUvq0lGy/cDdCmgSwMgD/0
TS49cNBppa5rV53Sqq6jom50EK2m7q6oLYyamUZ2b8Qxvbn+CUQH7D8IDAZP/VDy6IdM34a1rU6b
Pd4ltn6/rt87S62BYZKtT5BdYpodnXto/4AAgZcxJWWWJTOFszfdwbQeylp2hAVrsaGUAtwR2PNw
dbN/PzvCVE+cYUvwiRvz85R9VgC5IBjgMfbXt0zwnUA5ipQSswHga+EFk4YsQSGFrPhOKe5T5650
Ng8kyB7krm7a5dd1Y4JNY4pvmCpH/gXWMO40QtLTTayU4DTST/lwW4Ft8+8NADiMhzWiOyItt2lL
T4uS5FhNXzfgGNCJ4g39YEfXrYg+DROVga4K3rzoslx+msICddwUwwrkNH0XrKwgl5VNpYu+y7kN
biUWbbKkXdhKqpCixAUeVer3aaiWf//gBT/Sn8VwB3WFG6/lCEMjWgY6oPFkeUQBU/JhZMvhLiS1
n9Yqhq7lSRmjpTl0iWeA5qL2s1rSiJEZ4rKXWLNaZTZgaF6jTQWhWvM8r4ElO50iT8bZdNBOB3gc
JEiXLjCtLRB+1KlOLhSMvA6PxBBdNE2yayJHw/gH6rfo1kNmmltMXy1jjXZ9fQJ9wIsb38epvZsL
Z5+UfyvLhAvFwfMSlyTEPuwPNCCD3mV6uxn4Pk1rHzuj7z07Nap9ZiS6JA0TLIpNmbDI5kDDxeTe
5W3nLClV3OrkKGWwto9N9aYzzv1OUnwUPfjQ7IW4AzoZgBDxmjQmVObsotGqE6s7flaMp9H62W0n
aqrerBwdf9P9ebhXpMAuVr3h8iDQnECZEcgSRsvFRbl0iVl2oVcntR72a1qExvTZBTfszABTS3Jb
mx0qWEfbUoK/jkugI8XLCMqaILHh4XrJ6MZoYcEp2Qt3MHQvqX8si6dqj/9gx0b0A0QIyhn8+6tR
Oosp31WnBCIJ8+LV/WHsbmkhcRQWRj/sI7YQsHYMC3y4mjDvaWFEPaOnUntr51t3eSapJFqITQBy
AEpTFCM09u9nl+y4IV9VwZN0WpRnaj+nHapE5cP13RKECgB78IAEDpuNUHGRPK0WJ82t+n0ZJtqI
ffV43YDoQJ0b4CJ43agL6Lhbeurc27qJNsiKtd2ttBsiMsM6WDhTAKFgaOtyrxqI7NEcLD6nltzW
84NuB3ihSfXhRFZQQ8C4og7cAKSwLq1QdZ06i+T0RKZj42SeUfycku9Z/f3v98xEmRc1eFSVLX6K
AWqeateOIz0B+xpVYZ9gz6CO5Up5WQT3EfDA/zP03qU787DVhvyxUk/wsBF4TmcIYXAHzb0HJI39
dGTvngyELaX5NS+DbLcl1snp3cO2DN70qrpf/3rZgPNgGpQNg6MOxrmKuZFmHVJ0zih9NqYfsfVZ
se4zM7puRXCqLqxwl33SjHNNKBrZpTsf3NAsVm9rVEmwE/U3GcO0QXAzwist7h7RoSuV2Qa6V0Bc
1CDImCPsZatCiKTEUG20ZZan6VQyTCRcGpo2LPIBFaVxN3JeNaTNtak4ZWqUNq2XK/dkkFxcgiPg
gi4OVQrgkdE0YwHlzGXQrrVtOq7FyTDWYJpBUlnXu8LuvLhIJZvIfi4XYi9McafN7Rx1bh2YWtVb
K5+OWTkgmblBzctX6Gva031CwuvOITgQFybZ6s9WF+tU7ReIq5yc5bENaH0Eut3rzS0gq4zNTbY6
ztvTblM1xYapxgzjp7Wt73MLCr7PnXXfFj9iVyYjJCoVgi1cQ6cTnoFpAO1ybTgUcbeSDf3O/iFX
Na9TUtBgtuFm6MEKehcDgnW1r9l4MFStjBhP5JrnxrnzgDdqRbQG31Kjb7NGPAI2yPH39Y8nyqku
Vsj5pj2kZuo4bIWon+WB9aIQ3wb1k+o5YAFRvVUBiWvUmjK+GvZ3eUc9XxznqHgkJ+tMsTgy1cHU
jEFitRLyFBaVrpngHHMdtjhRY+Al+tSfIwAQLb8P+htZg1+2Es4pMTIMnFhCitN82C2SdEb8t5Ev
4QWMkQ2+wVC7S1/HLnYJNVrtJLs83itYH3fof3+ep9KpewsTPKzTXt6sj0ZUvVYgsSy/AMHyqQsP
teKvIQRYfFlhTbIqnqg4r8a+mQ1UEpWh6+/6hOkqEMW+kbi2IG2Ha/9ZHXd4K7cvu7LC6npP9yBe
6WHs3je8Miz965ZEYYnhd00o4aIWZ3AeoFB1IElhojJ6i4aPwhRHiz5A+x/Vl/+nKe4mRptGp90I
U7MGui139pPUCUiHsrP2vR9uivEzXWWVMdny2L+fBXhFXbuub2GzRi+7m3cAtYEAY9ev4566x1F9
dRXJpxM6yJ8N5WtYiZYqCMoGVkmiYogUGaJJVG4FKhmJBh4iGCDmHzxQZeljGuvFydZ99/S5ORYH
JbR/1lHv/dJbb/is7o2dDKwvjOdnRrl9hJqIMk42jHZBEn4eJJ4huoZB3Y/SJcY/UP3jnFDL8HJW
DBdgQ+0HqW9VqJRa1SMeP2X+910PvK/+WOJ8MLZTQtIcWBdMmtfZ4v1sEVuNavcPh+rMCrdbeGCB
xwvgPVxMiz/Pjb+Yx62Hzs+jRokXdwxnIStqffQ71DJROIH+HbCSaHpeejrVksxRTKBfegAedoTM
D3OnytxAkFQwK6jNYpSX4Wy4d5e1lu2il2WJ9thieaWyyye/1c1Im8C9kPyCaJRHl+w4PcV/K0YE
PLOKKgZOFqIUIOzcniK/tkaHAnszEdfbaeiY6HmQSuqPH7PdCyM8r4rVNxnyaSAboFQ/Q80WT9de
f4wNiZl3iOXl5XVph9vGcsnUctMA7ClbdV8n3/OxweOyCAvASrvhm9Y+ElRN3OW0fs2raKI28A+k
2a9KI6FPE3oNKnroyUMFHIN/l17jKJ1udRUWbFV3OpqP5vZ4/ShIDPD6nHrldk1b1sBx2C04hZ7z
JbpuQPD0wl7CGd8hnqwtfrmEwtHHqrOxl1pqQNvLxKwrhstvJ3qfr6PX0QPkTrxklXF0fczQYJbh
zlF2x83Jh+EVSjzIQBaYLUM8wbrfmnJfZVU4qCCllYEZhLuIuVoGGWHHj/OXJSe0mBZmDFqAtnKP
x7SkuvsxwGM5rPniOmAWQsnwchfzGJqmWwoLRWohg1490AJgvF1WgpCZYQs9u49RQAPMk5mpALFS
G0w/0NsV0n7XfUJshaFlMT7LSpCXVvIOWNox3tBDqnqoeT0kxquSSNLbD+PBLCAB+wDEEKqbgH7w
O1ai7WmoBZZyZ1Qehh7cHs/Gu3yMDO3Z7HU/iQeIHRZhlieAqj9eX6IwhJyb53YSw+UkiyscLBDE
4Y1+V1lftCzzHfVWKQn41QOlUb1qfHZyMxy0dm/XYF1XMG9iNZvkCH68vrET4PRjwFrM+Lvc9e30
NSR+DJxAI2q7X0nWBRl5hdhFKN/0j3nxpSnulluS0lTyFqvOOxrF7S5N7tas2NUz5F0wsuxUHpl9
+uv6XotO3/n6uAjTxNYwrWtVssKsbTzWk+zuZn+Avw6Ai8CUA7If3OHcqtpOhXjtBnSgquIL2mGb
fU6SR4hCWNHyqCiS0yGKXGBMQbyHwiNYprnllJvaUGOFtSyZwC/UTLUfr8oKw31xY4126U3j8pDa
9t+yUb2fmD+GeWyN3enUdBIYrli/Y5/MQUl+LWZkFl9SoED/4aOdGeNCptNpDajXYWzOfjvVbbxK
/r4oVTjbRR5OnpcAkvYVy0dqxzONx8RMvJWCaY9KkklxoAE7GcNno//Aoxdsu+ttdZnK04oq4jy8
VclwBw35/letHDT9l6JHmh6HIIL2J/1gybC6Qm/RWbaH0rGBqtFlLGWovQpMyeVJxyxrcoNiCvnc
B4Pfzq/XP5gwipwZ4qLIlCugPjCB+OyW18nwrRPkwvvRKxPZeJXMEHfa8mpdxm3AivIf6S5dvTXI
MIQiedKIriCAMVA2fefpc7jwrLV2DpUBrGapnhfrOetvafp2fcOEHoimJYPU4wLimcmcOl0at9KQ
8YeKV/nEl6U4wo06M8CtYQJYplg0GGhuSDBhaDLzVUn++T4e8yH0ndngrmpFtcul1mGjPljeo+EV
BwC1D/du2OxfO6/0QXzg9WHn/6Z43fq+43/Xd20IZTJF8kuEH+zsh3B+rm55mesrfohu3uTDnTrv
1PbL9Q/2QX/lPQCe2eBcvGjqLgflDlz8pGF++dgei5f0l/7WL94SdmGzm3wTDEiflS/Ovg1GGRMP
y0iu7TXn+GPhpBWBeshpDCGD6a3+5lWHuQqqxt+Ohqd4tl/vgJhLvPypCTsvw8GAksqnbEci+rI9
aT+rn+DgudHwL9d3RhhkAMFhNACAMPBcAGNV6Pmo6AjWL3pgAvJ4Invrxs72/z8z3AZYuZpooJJC
klseqvRWn98621voXm9/A1X7LxHgbE3cNbstnbPFDFhuLok3xN4ELo9Zl7RnhF4LThIwOBkmdEE5
rzVit1ScEUbs9BFje56lPPWdVMOEVRs/OM6ZFc5vSYWx7VwDWt3Gt8lG0N7sdeM0mz8m+xmt13Zw
fL31C8BWU1lTSBjkXCY/zHS9QDVwef3odUwzJcYny8i4QJ9dN7zV6UhAqq6lXuuAmue6jwiGb5Fi
ogWP1/D7fctFPTDODCCRcfA2N7ZgbDFJ5JVBMQamfjs3I4TMa79Dsm8+FAmaN9BtWgyJ5whPw9kv
4GIiWQ0A4Ub8AtWfzW9dgfNIo/IA8Iady5JB8f7+WS3nQK6VznhJxAhJGyRN0tel+KLErjflT9e3
VZTiguiDAIuCAVDotF1+x802ge0b8upkfk/bm9oOevsbzdZ7M/mkDUOotcruukHBQL4OhIODj4lx
MCCsOc9ZNLOoyjIFAAUMtod+1itv0IccEtrTHPZZUYVGDFZUPPHBLLvWaYjhPWXvDv34aS4a3Sf1
1BzmIVa+1m78Qu1qRLscFWuzXcHTgLlSD+qwTjhVI+aL6OgcirSDYKaxuLcOydwjYKzJzfU1iT6W
gRctWsw2yot8bblMaqUHhLQ8KU6/QzXWa4bMH9Qi7ECcd92UKLAwNbv3GR+8cllIOHuoT2Y2F1aJ
QQMTlxM0sBPaeooq+UbC2g1DRrIpH0h/8CQYbCgw7lMEluXX+IzZ+jpCg3JBhrk92b0kVAo3748t
npi2HnIjKzScKhTmaXsw64NJblRTVtoTvVABkUVOhvcchtY5R1eNDUo0DFe/JVrsb/OaBI0z/TDo
lvluPb/kxVjuSFf6hlH9rgBFDK9/OGGJ9uwHfFhnMw2YCwHKvAlQxsH8y1fNd79NPxNoL87B9C8V
HYNVjdCMwFfkay2a0xp1omK9VbkHAnXdma5sRcItBYYafCwYq0Vb7NIXM8Nq+nZWEKO6gDrRdhyq
XWncpvqD862g3vTj+g6K0l4G2f6vOe62y5cyA54bIRFN+t9d+UjiKUo0EPBXeTDIONGZO/BXK6bc
MNMDRhaQuXPGlmFoOtfG19IVf6M75VfZL3e5c2M6+SegVL8ttSk5dMLlYUwW/TZgm5CNXu4mpGrb
qU+n6lSAYjhpj9aI8TKMgKD7lxaSm0wYRQA4wqgR6DnU9yLWWRTpxkJbSQEMfN12uxYiBmrtHupG
dmeLl/THDOcg9oaqVJWPzAwmhOo0msBzAmRRoMXbIducQRIchWeMIZbY0CDYsiwuR1DTmJqzjSkh
rX5ahn1uVMeOdnsjAV5dBUFaHaF5lbbfh96QmBblBueW2Y6f7ahWpmihWnV1mpKgN8tArQIzWaKh
V8DruPru/HD9MIi+IMjYNXSHkRBp78WJM3ukVHKtNTA6QfoHamU+zW4zkM5fNyL6fudGuO20FlW3
7BhuUtp7sMF6eV4H8+i7RTRWfw8uZuPnNjwSpBD4n0sLiNXVxpiaQPxaleFPZKX+pmQAjpiqbFnC
vQOBH5vxxAp4UkV764k9TjPcUp+sY062NahV50YDYF9yppmD81EEYwxsAhEvAXSHL72i1ldrW5sY
KF+n8ZRxCcb0SQUFWdGE17+UaElweqwFvoCopV8aamiZjphsqk5rcagNBs/K/mUpZxY4XxhGOjir
DqB02t/WRTh1fhXfUFn1XnSMztfB1nnm1tBCnsArj3Vk5k7ZimCePquG1z46MQ2dcfp6fdeEn+ds
Tezfz6ylhu2ONgO04ym4hFumY1BytP2lsdOdYeNBdd2cYHHwA4LuLIZ7wSDKmbPy2aS5gTulh2jt
uh1m6yc08bThQNu7qpAECMHaUPQHfhNAOpSueRImtx7BzjmygNTu1/6EefDUiv3J+XvHQycHtz/w
le/R6HILC4w/JBSoshPUVGLT8dvxYCqyAyuIQxdGuI1Dc2ExdTYNUNBw7Px1ugUfJW1BuSKJ4iJD
6LOBSpTR9yE6XK5GX81tdQucV3QO08QIleXZUkpvtJ6BNpZ4g+gDAWQLwDeaewBMc66uaWul5LGC
IRQSxUWY14cJdJaTJO+VWeG2zm7MgvQbrFTkAL0ZUJ5pEOGRJZsC8AvrkwAAoCH8YKiUuf7ZSRqV
FlwpXUFPlYamrv4VHM+7ajRw69v1ye2Nk96/KQCcqehlgxz2rVCNKI1itDRSctSprAkggCCCmwAb
i9asykgXuGfSQNeBGhhgRD8KVOWp5ziAkSrdLakTL03ujdLX3WCcvicu9eJSprXxTifDxX2YBy4X
4GPMY5tcsDQUCNYnPQDdtMiiJj7M802rHLtUQctvesCts0v6FfWZ3u+WUfVN+jirLZTKbhcLpApH
U3mN7d1YRPN4R4Hpnclh0l8pihqKdsy0qBpuHBnPj4Aih20ZwAbgplaBKea2rKtUZUy3HtB9Oygz
9E6sZF+6ho8Bn9S3f1em1yRrqJDNt5XJw6+aVK/O7or5liy51292hOfqp7mXvXjZXn3YS01HPx9j
2aCK4lxLXawJb16AtBWtTsIFSXLUGO0gaRsLTj5YnSG9jSuUDXqwfz9z4GQxutRtMgDSyoO6eIr+
gveSa9/LWuDvP5dbDlht2csdNwAAO5yhkUC0x+zAtuB+SefDlP6y6Q8KYpxaz/1SDbp5Oy598sl9
ybvXoXpNs+nLqHUe7j5bhR5yF0tyPEGAYIJFGElm2kigCb9c+AxXgBon+Ks6UvhDOb6NmxZtuf15
bmRhXGQKDI+Yh0XLTMcmXJqa4myDtAdkBKqsCJz0RjNBYL3kvktlqAmxJTxsMLCDT/qBtMrYMsdo
APv/PrjR3P4faVe2G7eubL9IgEZKepXUk9W2Y8fO9CIkOwk1z6KGr7+LPjgnLbZuE84GNrAfHHSJ
U7FYtWqth5p8mWXAp62qARg7/xgRgjuUcJVyHBrA/HUnyCPXV/IfilP6FrUe7Olnd0gtZBNmtneM
/mMcdUEcHXuD7SnywVhOIMGUc/9+IB0YgnlXK/jReduKsJyp4pC2XgAIXNovWrRPxjtSf51k7Wsb
Z3JlRTiTpVpbPXoE0RJwqI+SDcm/UDwgaAdHDAvZQ2SXhRFYGuuWHrzj5767QyNocWe5YeuEv2/H
YhsBM9wcur/xSER3rpi/nkGvhNo+COhQB3SW2gOWy4ue/8IGrkMwRxsQzBILgaQF0t8FNAIb5MVa
zgVFF7CsnWBrp/Pu0v/aEG6aWc2LqGlhA8ldACZNP832OOtgv3SD26PZWnNsK0SvQHQBVyWsCxwF
q0kMMGhSPZhJ4g1Uxr6zER9DguePBWFXRS7w+0UBC/NyVKHgYrt7sEChbQCNEZYlGc7mxKEtG3Qt
aGpFH83aGRlTi4ljgAklz1Bpnk0kU+9kWhNbWxltVPh9nu0Gwe/aBlA9rT5HsKF9sZ0fzbM9vDbQ
95WBqTfn7cKMkNq0Szw97YEj7b4pQHt6JKqR7nhR7edOFiVspMUQI9jQSUMBHZhPYbtVekmdpQRu
u8y7R9vsPrpUfcgJ6i9OSl40RT2gdx8NLMUkOa8by7UyLETLCphB8qSGx9HpFHSmjvx+54GD1jPV
VuKAtsaIMFbHQxOBI7im16tGzcWmCgO/6YKYcdFO7vizfnTSQHs11M7Pib6/fbC2QgJUDf5nUHx1
IJcyZHmPkCCqGu2DZfd0nxpl9kCnvtgV7ZDu21zvvSHT0D0RJalvAHXiu1M7+wmIwLyRJWw/I2H/
Uow52OldSKNVe71u1X1TQLhb8rn8ZAgOevW54skB+arhUBCwOoVxjt3XuEk+pBFYd6Mwcb0OtZu0
oMEwzZ5jPd22vbULuOvBhgYoC/WW9dJk6EzM9BgzZeEl2Guzx7QfjoryKlEkvlvnGZOrUXIRAjxm
4B5cwVQEWRq71hGsGB0ohpudk/YQ5nICkKUejS40ipDaqYeaoN855SGNPc3elw20sY995AZqfXCJ
X01IH4OkHMrAqVt/MQbZyd9654DE+79fecXO2c8dzaNqQD9KsWPdV2TMvHl+ZMawV0CSCyD453hc
vpTtqWMPxpB9uL0cG44HmHZoUAJ+BA5vETimL7XSxBnCrJwzhz2RqPSV2tfYDD0zIwCs9V/aE3Ze
Xo+ZsoxYkz45o8fIM0bzRN1T3RceQ/FPpmG7PTyg8cCQjtTk26P34k2QKLEzZTYmFxSlnuK8Kkbn
EXv0lHraKfrLQDvJnfRGLnW16d6IT3h7Pu719f6u4cxKax6xv0dUfVmGlsQ08WKjv2sVEtSg2zPK
41y+tml7zEd1n0S27zTLazFHp0h7LqA2akB+KUof+2pfuXtqOJ9uL/nWCTSQVsI1jSKFJbYzOAQC
L22CNhqdMeAzFDT263a/r/V5RxZjlrTbbbliTD2ffoTawKCs5yOu7UGvIJdwzqoKurmGVwKHQ9BT
ZtAPTWdBVlL/tZTkeHuMG7EhX3MAlJE447WEtdW+L8HGBIQwiJNeFLv0luloL19u29icR7Tt8v4u
YOPFhEmlNujHbxB/2un3vie8o4FTlSYyhYYtO3gIgBKO40QAFlyPJSpo+x8SWT29q93ZUw3ql8Oe
UFk6a+uwXBoS/KWid0ZJCQLRLh72RUNfJuepbvfM7A9TG+2Mjh5uz+BGcAVOKwD50KvOAfjC3gC4
pWL9G/o3ep2oeV+a9yrza8e+K3QZ3d2mLbCwoiIOoiWQl61nsVJHRnsN7RhOYoLjfRx2FehKa/eh
z5JjCfCYd3tsW4UsnoT4n0FhC7ZRn88FAZ46KX4uyj6PzVdN/QHFhqAa/Ik+LakZRDjmYCO+bXlz
pAQlSE5HARETfi1e+Lwyd1k3DWiRMssg90zDn2PonUr83BZ01sXrC8kc9NxxcdW1FVAxW11qAuoJ
tWt6ZAqHxXfNEtjLYKK85CiHkkR5WGYNDQlppl3qsKdYo+7HpNGtew3cCJJP2jrzXNCR82+A61pM
GHY241KmI7DyHXos3N9O+zRRWWS5uawo1/FkFv6Hhrf1uJveJmwwNCCIzPFhhNRwNdmBxYo7jRL8
v4fSoxt0inlnDU9Zv+xvr+32tKPMxvsv4E3FptJyMUp7Gm08FGheeFaks6CZk3yn1jEej2PDfLi+
3jezMgrSYXLQ8zSVfk/wcGVDrZzVRWeS/bY572hDRo6JIAcuvirVYqryxOI4siH3stT2lvlbNshY
rrd2NVYWkoo4UqpjCufXcctuqEZOOto1wQLwx05Na9eLkiE9NEPx0BVPt6d6yyCSXNhHnMYVN/l6
oV0CsmLG0I/XpeS+GL9qKlqf782lvSNJdrpti3+8GDRc2hI21eKSaFp4o1UXI0Nc65Gyo7NpSy7F
zb1rq0A4gVkYiq4iUxIkgfORujizqdvUexDWpLs4dqI9OOGswJ7H6Wipw7wzIB+5I/nialB2jNrz
7BTkcHvAW1cNb4mCfgCqTljP9eQaVTsThj7ss7nU4OFlABxSEGPvGc0mPzfiHhIG7suY9EziJLYu
U4SBIMBCL6yNV8jacEmb2EwjzDQzfrdI2LvmfTekgfMXmGfkvyABaiI3Qa6UIGo96yYzwgABGUKQ
45jZEXWCJuhnKnvQbw4JmTYCqCFUDcVa+MxwCXQ1bjYIvXlW299nRuzF2W88/yXeZ+ukI1kKKBKX
p4LXX0+eWZvR2PGGhaJ9RpO+l0DlSy/mv/AnEG4ywPyLnYFc89oKWspBFMtQY60Qpd/jufDaG7F9
XFwaSe7orZlDjIhcNoSVAckTjrhexS61HBRYU+7OG8+uHqb8HyuWPLc3p+3CjHC656VkSe6A4hEV
XD35TUfLc2VV982h8CoAij8QGhA7jwD0z/o3/KLbPsVRHYB2zy5yLy6+3z64m2P5Y0d8L6JYV7ZO
iesv6Vpf019jiH/UmcQ7bLlDPNlRxuU06JYhHFI4pjrDRQJ3qBmgSiqCCJvt9ji25+uPCf73iyBp
nJVS6UuAMOvoUEZOYOof0Eio/gWIHA+DP2aEvewg/mv1FiPJgbTQXgf31Ea/bo9ENlmCK53adqgo
OsrOWux4StP4VLUlTnN70f+MQjj3EZApitlwamzNBpdjGwcOms3AG/83DsZFcIMrl6DlUdT4APrc
pXYEQ4OZ7Q39u5GhP8b5fXvCtpYekTn4zcDoiLQHn9CLpa9IXNJsBCQKx9G1v3WW4qHdJ5jSXrKN
+bSItzpnHcPj1wVSWnSXCannaHFBEEgQGeZPCfuO/voKSiOx8rmd6E6b3h2yAAcORBSAc/jvCo/Q
ZEB52CMOZzahxWP+sDidp1Jg+fXsNLZf3zuNaFwDq/8bZSWSR8K+y6YGhCMl8AJd+VDVv+fqXI/f
KLiybpu5jhS4QrsN/CtnWgKb93q1lFxfFr1Fgko/JDts7l290/xccoauVwpGEM6jDQIaNqaI/lYr
u3DdFoiREfweRA0ctdi3kFNP3Bm0R8THDeJZyny8PbSNeIzTVYPJEbSsNrLHwrmyjHEeixipeFDX
psnBMn4bY5R6ALf5CihwMjPzpqTys2U+q9G7zzRsI/GIU42pRdf2el6TXEUWKEelBpfrqTZAEz1O
aB2VnYHrw7Y2I/hZs0p606n5Y7TpvLTY98j5E+2ZOPvbc8kd6fqsre0IjpZYjVYuaMI+O2OxyxrA
b8f70ej9aX4ZVZlM6LU/5Ma42iE2DGIH4YWtNUuaKmOMiKt8zPNHrevBgiBhoNvckoAxALyJuM4V
s3RFBG4FaE8hQq4e9IXTDyvfU2VXFf78YsqK7dsD+mNM2Iiz2i61o1Hchqn6bDSu5/TNvT7KkqOS
MYk6mUXrVI5ZYUyR5YFIewGP2Ajsjg+eNGghj1TiOiSjIkJ41zAlKlQVoyJ4mObdfa09Efvn7X23
tb9xX0HeyQRWD+H3+hgNxFbHGHzzZzU9qt+7b+5AwVL4698ZEZan70aT5QaMFOgUJuOzVkDYw8x8
aYF4a4EICqmoy6BwBiG79WgaDKdmnFKEszuQ7DQBQ8R+jZp1Zytg/yh0Py8KiSPamkFgvZHR0IH0
wmt7bVNriQ2FSzxf7FT1ECbVDt0nLA0g/nR7Fre2w6UhwUUYZNRHveiQAexyP8NrPvmJ0pFkNJtG
gEewUSrGs8IRrivXWsCZwY3oMaRgi1+9fpDG+hs2NBVdFBbgTuAfFp8tneEMqdqpaCc1UxSs7oB3
9Aq8Mm9P18a6aJwPCBZUxDCijk47JjmYWICsBUHVE5mqwOkcQLm/SmlmzGvXDUOoloDewgRLlbDp
IuYMpWIDGtoPEx8OinaSQGzjcuCoRnDZ4EEOxkbh/ID8t03HGpBkIO0zcEYhePXz5L5x6b6T8cls
Lc7/bPGpW2/naSYZS1UsDvKwuzHd9aYpV1baNoLJgnyHjtZn/veLEJbmscaiGpFlR+z+DH0tSMi3
TEXmk9H97W2waQq3EDBkyIHhkbw2lZZo3dNZXnIm1L4vAjxhklb2GtsygnYZsJTxUh2IeNZGElBv
GX0JNmCaPPUNJOb63gO66N2JBVS9TKQPUUoBuEq8tk1akBgXW3lGpvr4Q5Ml8TYHAbEATmqsom9L
GARzx3aoKxBAt/FOs+7t8mDKWO9lJoQbrbdTc844BTQocE0UhfM7Z/j9/vUGZTuAIaifgYdH8JJZ
qqhqbcBEUi++AtXxgmsdyXr5tpyLxbOQCJ4ApRdrZ2mpIcBB1g8vShKMiQFU7BOE6u00+Zs1RxoJ
BQq896DBuN5ZJG9ru6NaeZ6rHXJ9WBRWSlIiW94F1PP/NSEym9msa8w808uzS5/BVtKBs42TEqto
EYQS2e728mxNHJ81vCuxzcBUuB5PbuONbLcueKaT8pSaqY/zqFVlEC+yxpctt3xpie/FCx8zaEq9
0IGAodv7Ov7F3XL523yUF7+dkGIxURkuz8BtKcjAxruuuJ9ayVxtLIzOu5RRl8Dao01obQXMXhCt
rNHcuOTfQExy0srjoibHIrdA+SbJ8W2sy8qWcGzUmThKrMDWeGfOSdCrfgexTNlu3rKCewzVCNzL
EKMRRtTqnVJBHBOtGn1JvUYBgUvf/LPgaRnYahFJ5m8DTw5feWFOGNQyp3Fm84449VsXQ1y4e+6K
dm8iD9u3B7N5saafKOYbs1eke4eCowpSB914dlGghhtBj+xRkc0A33XCO2/1SUK8XdAqLVIXMxCz
ELTuy/gYy7ADGxsfJiCnhXI7YgaxwrfkreEuDu9AnAsvo89a+3r7DG+P4Y8BIeCpcujFx9yAbeNN
bJzK9sPo7v+dDcFPNGCEmjsFzYWD85HR19GJPByx2zY2+Bz4/vgzED7Qi2OsDSZLwRuBmbLI4EOO
qv8IUntO0jdRf0LH6KNRU3CaE8hgL3lWQctS1faJ2WenfnJzL411yx9Klj3f/jDZCgrHhBbUsTM+
wY7zsZx/KuzHv/t94Vwkaj+bEWSVzyiS7VyrC4c4kzz/N/eIw5G04O5F+COs36J0GRlURERTf2Af
Fe1OkircnCJk7RB1462iinUwBlQUVTKuv4C6sR7fTZ3spMosCIvAjKS0oxmyHhX6vYpEhdzy4fYy
bM4RonmAvPkzSIyCDVxPlCgLxGzS78l0p5bfQGR/2wT/yCt3c2FCGMRsTKScW5gYanC51/6g79WP
M9Kqt81szRVyqeDvQC7QveIKNdWOpc3AeyaH72r/rZNSr2xN1YUBkSt0joZRUxM85lyzBnHycF8Q
9T6l2e/b45CZEeLTjmQ0HQnMmMz2evteA+e1rBghmStTXzudeTQNZVp0DIUOnua86M7P24PYWnOo
PvAmZp0r2wunu2SDpTI+V+WoH0H+/4soD7WN/vN+kUH/N8cCHAdQzuAocMSEmFaadhyrGEtXf5rA
DF5ZMmFEfh+KG5iztPzXgrAiSm25E1d4OkdL87uESomHRraq6V5s88uU3S92LLN41UgIKQsbpRV0
K0A4D0yIwpkpp7EZ60jXQl4jsrRpX5TzARW9zyOw3vp4MlCeTHrwresD4LjQhaBBWdCnqe0+JGW/
U2YmOV1Xefa3LwLMFfkYpOoA419vGTYTqBMqtha2avNpQdHSjJB2LD66rNhZoBdtJ4eiJDudeuMz
p5G+vZ/4r18uAbcOFTxEa3BS6CHhm+DilhwyQgZ3UrSQKcq+mO+0LtuVY47c5yfNfb5tS0zgrW3h
Ob22ZbQVXrgtbGnd3fypL73R9NzP5Ez6u6STuN+r6//NGKoywNcDUwI4x9pYiqV38jrTQxNpSUCG
fVdHa+bPp7R9QZXLGwm9J/3sQ4nGb9muiZ5mNG3eHq94gPgnYG+D/QgASR6Arz/BJUOamYOrhTZk
FAMFkDPftXNZDuQKSf5mBt1QvCEVYaFI7KGbYJV2aKKHJYsOGv2BbNaL0XY+GA92thHfVVMbsihg
CGxUQFmiKWyGZV/X9e941g6uRf18TPyE/qxK5k9LcdJqMGk06imlZnB7RsQDj7sQVFCoJqE+gSSE
SMKQmzXQ8Fmnh30LxvA62jX0Nel3nXFCCSmh9q93m0OzKXRyLK7xDVDxegEMkipaO416WFPm+uMM
ZaXWOrYWysTMsfy+ndHMMsoyOVcwOIwSJCsgtdPAneFACGNtVnPjEkBZTQ9z6u5KNOFHtQ+Mo2ul
98NwR+xP6fJP3vw0UWQtwE6V9ZNkmv+fL0C6Bw0mgFuIvBBOHLnKCH2pcErG1O+W6pTW0XlQo9+z
86PQfsdK+hFIj5OtdL+iRPeGvPTZxCRn8Pq883lA9QGigagRib5livOSIk+gh+S1sCCnbvp4tOyH
VEdewDo22dMsa4jacKZrk4KLKduKFqwwdbQ4D0OQZEazt5fFeNb7dNw5s10EZmqWPztzQA01N3K/
L9CKrAy1KonNxGDjP3vgz9iFe6ZKHZLAqeuhq6TKfsrj5sPsLvneRCZUEi1vOAAM2ta5wDCOP1Z8
vd+IknasAgALDeDmPgW/lEfM5FPqBlBf9pXuMXGfLAOdsNOujiqfVA+54i2felSOo8di2jvTP/bg
zeARrQbUVbzKkYnobdy66y8UZoPSGACgXtdDWkU/TTRw0X5vuGw3T14UTXd1/hHJ/n2ifo6cEyil
UG+j2kPiLt4gU366oh57W5iLyRKu26VF48+Cv4cg4rA/snmvqeDPPY3smDd+UQdtKkm+XPXxvlmE
FrWFGvobKGG9PHGduz0a+fVQNboREc4jGb1lPLe146WgIkOI2KT1UasOkwXWiX7fai9z0hz6GFFq
s59pOGQoCki+6opCgH8VPkdH5zu0NoEiXX9Vo9cNIGy5EXYDy1/0Oel2kKeekBdZ7tvIUB4XC60h
PfpWnlPWuXBgpboDSP1Ji8AUjST2V3vox8CNCEg5UDYNEtdhx9jtvuMfhW5N1A94n3/Reju76+28
fKoyvXgY0AEeTKA89s2lmE9s6LS/cDrgt+b4cmTWIHCwHhe/8glj4DFoonRkHvA881Olua2P4q7i
Vw75YADGU3oVoISezdBx9f47B23FsA2oBirxwv4CIVWvGwvsE2YGTevHBjR1ajTZlJ4yE691C1kl
+aq/D0vJ85WoHmE5kXoT7htiKyBRiksjLMgweCVT248Tc6pgSPL4H6u057NhMgghJF1WHq1KzXx0
cJ9pprVHPU/moG2p+32se82nSZP/cquSC2g18VlpovcKr759Ky8NAXiKvSMi8zO0K6eNxoxQpcuh
MXXmxc2gB8OUIUeTRKMkC3QdghloNcANqKMXG1hewfGUE9PSoWdmqPRfdCifVc37txscBiechCoE
OtWE5WYJbU2aj2YYlUiXVU3QOI5nkCeSRD7Nh2Oeed3n2zuM/+Q6ZMdLHBKeyIyAYA0NmOsdXhUV
s2uwGoYLkrBH6Cqk9/nQGp4RO5qvDmm6qwdS728b3fKbuMp1EP2h3xgxjWCVwIn1JqD0YbtUXwg1
T40Rv0SJe1yG4bFhIQUbWbckd2bUS1zVRtAI+VxgkZDMA1WeWIKd3BINp8wxQ7fVIe1lLqDsrKxp
57KJ7JNMIY3HlORXW9JWsrgblzi/KdDD/cYJK8aPkQ3pmQio1jBnrpdVBfbqp3aWXN8bWxRPP/B6
IrnCS6b87xcvMKfWqgjYaSuERmcKZH1ie67SGJJ33tYkoh8GOGwLm8YQ3f1UKFWazpYVqj0LkaXw
7fj7FJ1iGu8ABIR2yvJRsmF4cC1sU7Slo/8MFQG8asWeCKZoZOhrxwqhfEyfQVRaw++o3gJS5Nlr
Cr/99ruQoc03jgYiIGAP0NFn8DfGei5xK3SochYkdJPXstir2SFZ2GGmhV9mk4RWe8sWCGOAR+EM
+YYIB9Wnhg6VlkFDeQD6jyg7rdF8F61FRll4bvxFMp383hKm8y2+Q+YHyX8AetZDG7SuUXr0q4U9
7/O4s/pdmRyqCmh6PXtig4PkWVBUMiLH623D+5WMNz1ukIqJjWlt4ySxBerIsIhGcMFqzAdDrO65
pPVUSDcQowC9Sjslu9ujvT4TMMtJLRA2cbit8HDr3HhB813mhHqbzftaS49tlspYdd9YKNdTurYi
3Juzgl6eyiydcGjiLwbUdxctecYhDCKwSxldFDRK82H8bNBd7sZhFylgk/rJ0mRXy5LF13sJXwKf
jowUetZccS/ZSoOS1ECdsG7UXZHcq4pXQ8RId2M/pv7tueWO+mrUF7aEonPkdg0juCvCMk4Bwp3w
DCc7I3+s80XmdDYuDT4uwGYQEEHZmvDtdeHb8mk0G6sFu4rGp1RhyfcErSe+mtVZMNA288uq1e8A
fZjARWrb96TJxs+3h7u1ldA/gSoCXDlo5IR4cMqqOWJj54RKzBzwg/Xoca5N83DbyuZIIcsDSBK2
KwAcwl7qRmqqC9igQ5p+nOoavQ2WlxuPRVP6k1oc0qiB53OCNPnntuGt1UTSB8k0TqJ/peOo22wa
aooZrkDFcFrGaXqyqHpvx5N6D1CZenq/ORDOO2BIR6MSLpT1gmZK56IitjhvN6KiPI7ttyTG40UK
h9latktDggdwJ6Oam2Z2QobCBp7MqSPDbsssCCtmJQlU6wpYUM1Qdz/NsWRLbLlOCDRzagfcRCDp
XE/VNIwteNpUJ5yUxYt+sqfh0VgOfb23ZFm16zyLyavuvEsZgZkrQknLIrOKaVCc0K2+RqWHSHqg
QT7v/HLyRktCZLY1bdjiiMQQjaFZT3AfidNi0nLihEUGnSuzilofctSWxEldR16AKTloKoeMCicI
F04t68mA3pHODkvltZpUf3YqP58lQ5EZETZznblRria9HaZ67HWgm6u1+39tRNzIxlA6UT1gJDn1
9foBxZYgsSXPnI2R8BojGvo4P7zxdtNd+FlXw9Ndn2M1nBN6HHMQpTSZD/re4Pbp39jSeEXB1SCB
y/H5wpZu9XG0EqVQQ5IkgUurx5qeMzNoc/PzAvIE0k2SQvOGd+PKjw6CLKCYkcldn6EZqPkFHlsN
a3DtWy/QKTFaz5VlaLZmj2uQEiTPIEQkPm1KlU7DXCxqiNiZHZ0Esg9Kae/jSVbr2TIEnl4Qg0Et
DRk74TpEUVtVex3zl1oVNCQav4zdD6wdJZ5n0wzgZCjMw/Fe5V1dTKleAV0eGkA1xPZ9nH4crNf3
bwXcO/9psgHaS9gKcZ2ptel2aliAentu9yVjO1b/YuVnsG7nkgHZWGYhZIFjA78wl3NAiMQHfLG9
SzyKnMbGNqAPfXTfN1XQEIJk3d0geWpuODfDNFEd5G4H+RThkZvqdFFTu1dDhfwwo99jJTmnst/n
A70YSKfpmRmP+P1lfnCq73/3+4izeEIIYftblHLx++iNTnPSMDUcnKaD00wzL3Pb4+2l39peyG9x
4VD7TWhjPYjGKuK2TjU1zKpfOfRfpmHwNZn23uaSXxgRfHNkaUo3xzpGwpKdG7FH7GNqxd8N9Vsl
7cXYcjOXIxJ8tN5RmrFeVcMe5J/o7CunwctIFliKZCNvOVC4aK7ZYyJhJIqqga7bTBmWLkTzVOVF
3adpeTZhkuwLWe5ic6vBy+BWQHIXyjbrVYp6iodr58JXd6gILh7YFL3b+2Br1tDTzZEheKkhv7a2
YFqjtuCJr4ZlUXzXe/NZnZs7I4VyW7b/C0vw0Lh70MQCH7C2FCsWoAAofIbE2BemZzV4jnoVkwFd
tlaHe2fezwfWKbFk7GRsjAtEPqE1uN7w0Gtgo3VRO7Z9VY1RrJbE0lvnCJV3jbfgumDvE7wayGDj
CpRdKA9HymOKSjX+za7Kvt6euysKL7y/3vrVOVwEeCrx0gYgUcHbKOEV/ua+pFOYZNYMZSFn31t3
xB28PqGe1g7PfUXPk5oH0SLZKFvzisYdkNJyfpsrGq9Ip24C9lctnIGcN4dPlfMBrX2TOh9aElT5
0+0By6wJm2UhNUFLX6GFXRF7rVnvOqqOID7y0LqzKPOu6Y1KEq1uOSukZFDc5pkZtKOs96daZnmr
9RbClOhgJqnnjOygu79SqL0wc/rx/vHZvN0ZHFnIOov9ImqTZszMHDUcayzjBDV75GAcOgdg3a56
6kELXLJ+m8MDks0FkAFZWNEiSamhTRU2ql6koFTIQGbaeEZxRNYZQaYMNbF1LBzofln8IuYdJOvJ
dEi6oFTYaWGdPNfkTo/urVRC+7VRJkY4cWFDX9solqRyrQx1qgmRf00yHD/T752XUdOC2dQ9szyi
HsaSf3oZP/PWXPLYD/EMOLCvylO4UQe9G1uNp/GWGGL09J+RKOgEPSDclLjNrZlE8yyYOxGy84fh
epRazIxhprBFmmgXZdansqn9vnuv4B13MIA6IDkIaSo0lQlmcAVZc6YNKPpVTwZUG7FBxryWHDH+
I2IIiM2ASqUG94wEy3osyEM2CuowWjjSxh+zA1Vmr3U+LJPkTbhxbaLxA4SDKpLxIKwWrs0SkkOK
yd8CU54t3oRy3VGvOn13+wxvjIa7CZ4sQsbIFIuEi6nNU1VOaugMxbSjhtntDOiwMXCPUqdWJB5x
Yx/gbYPkIlh8cFfrwm6vxsoy4hGxlJl+TO37pXuWSkFvm7B5xzGiTnDKrJcnwoNpiAbc0DngZGjr
J/fl3DE/bjrJ+sgMCWOZnC6rGww2JPXvIQnr+GmWtf9smkAlhicNTXRo8C1yEUT3qHnrCR8LuFE8
Z77D/eWVMu3szX0GZjIQtaN8cEWJUiiJksQjFyfQov6+mF3zhKrp57/YZnimo2IAN6CKlPtjVFiQ
Z6i1MDfHPqgjK/MV0wJL+BJ3P0HtOksO6ZZf5dHmGzsGf0QJq7N07mhVQ6mF6tIMp1FRlsC0Gii+
g/AIuSIl3tlJYR0gDYWNDlTxftL0OmDKKENAbR0wnm9WkRlDi4245Xs3QcyjoJFmrlKP6vedG31i
ZUCU4fn2FG8lfvF0gM4P0JOc107IVOmjSuZybrRw2bfnpbvrjWOce4fsBSFjL3k+blwe4M7giDKe
7YNPX+/MCaUDZo+wBeSXZ9XHaEaAkWmeXdd703y9PbKNOIojCoBehPQGVytZG6vpOE9qh7WsirAo
QwVNGgr5tgx14BifBkfio7atobgF7w5eJbFSoKFk3cQthgaNz7nYTahI+ubPBjK0Mq62ra2BS+p/
lgQP3/cpnH8BS0zzFPtHXXwbrdEnpWSttrzIhRkxg5mPbgIaBgRNnfOZkdZX4++FK5k0/qnCpciT
FP8dikhfSqdxzDrG94PnHKr6MNi7h37xh59jLhnN1s7jjEdAmRrIXomUaIvrgPSqmhBKGLWOZuul
3EHAqD0hRB38sqjp49LHslvyanjASCLaBHYWWBrUA4Xt3iWpirZ7xw3BsuLpET2NlH3ph/3kuidm
ggBl+Tlm8afb2/5q3ZBm4m4ZMQYgc1cSPSrIZ1nLdCVUiupRaU6pWjyji0YWgfLTs1o6bgZYWI4c
4Q9O8cmQ14XimpES5kUTaO4L+Wk2IHK+g7tq6X5ImtNUSpKpGyPDVQCwl4rOWROlifWBLrMlXVCl
iiEACGXZ7tCzxXu3bhwXHrk0ItwAM5w/a8ChjY7sU5zsaBYYzpd3r9DKhDB1UcR0o7BgIibggUCW
Die4loQZV9ezMAxh6ymNi0fdOMdnclfu23ffGfh1gEpwmpByBpkFd1EXEQYI1/DzNlZiLB+Q0/es
z679NZ/2dLrrq98UpHUOe/+25nl7AHGhGoRGc745Lkw2xKyrvlji8zwC/QxqvLKGEBmTuIkr38oH
hrwSLCDBhRhqbWWkMUpBPYnPiLHf+rPrDCz6xd3Mft/eA1f+aG1ITHSqpUOUTjfiM0sjPH4/FyDs
JocWQGtVhvC6PjbIBKFLlwOZMaarSzdSjIq0EA5McGwaVPBy6iXvvi3ww5dGhOVhnYkEyQIjShzd
qS4sKN2+kLGGbg4F8nY8rAUBiAjIjmYrZSxFv83ifDcnqBnnd2UsWZlrVAUfyoURYSg9izOuVoIG
UtC6xsUIJQU7aOvsy+ywezctNG+MWk8fzF08A4VotGiUqhuwFWE/tnVogxjw9l7ZGjWkw6AfB8YL
gNGFTRnHfTWxMknObnyuLRtlqgOogP+VDbGFzVxmM421ODlP7rdWdX1+hhuw7fw7K4IHN7PYrboW
I2nJq9XVXqF95NpN/86ILpzhspvrhBsBY0Cigm5/7gMrkVFCXrVvI+TnKgt4MALYAT4KHhBeOKRO
T5IKmmDoLmMg5nXi4xxRL4MWY+k7Q3avDvUOEoMeKZOzVn1OyC8jB9t3VwCvnUFy/hc2z1HtzJOe
1N7SjpL1vHZkeJ+j7IwvRP7cENfTVeOxBo4LtHEmqCQdW8n2g0YKPwFF2G42huRwe9Kv75u1PWFl
7aymWmbH1bkB/MhcuiAa/qUFYVmzHOJr/ZhV5ymjoIz7lcjeC9fR2noIwrXM1AiiRxaGgHomG1qv
TWFH+aWRp7YiAdKiOzI9/7tZE27pLsvwpKzz6mxUVgBWE2arklnb8B2rfSA4M3es2mqI0uo8aIdp
ccPFurOyRIIk3DRi4/kIVivknsRX82wlMc2nujrPqKn4KNx+YTV8SFS2v94/X/z+xxMdBw5V9fWZ
yxIVYgpLU52LeIFYI00S8wHdYTIw1MbhQTkIwQ0yQSDOEflTtA44bmXAshTPBheQ+DJ26LUcJSHa
lhUEGQYohpBGA2HmejBdn7tDgqjmnCm7olafmkr9bXYnYNZlYJSNw4mVQdscGF9RwxA5xMtRM3JG
SghNLmUVRiTW927Sfbq9NhubgJc7IbXFmWcAfFkPh0s91tDXqs6pSrvTpLX0hzKNqdcjfSdz8VtT
d2lLmLrRyXSkhmErWV7Vpj2B3GbCnWyWmiwhdP3M4XVV5NHgSQEXEOlnejYjc8IITqgNlQFEBP6S
DYe6bX3DyAOmFj6EDh7zmJy6/sPtCd3wRyvTwoQiqVTEAHfjVKEq7mHv60H+f5x915LkupXtFzGC
3rySybTMsl3tXhCnT3fTgJ6gw9ffhVLcUSXISUbNaKSQoqXeCRDY2GbttRCKJlXI8t9e1voOCFH6
dN7qdq1uLjhwwFqJYBGK07cfUqOk02hbVVHnQ6IiV/0kOTrD6f7iVk/Lf43Ikk7E0JMBiVYFWVx3
R+q3PgO/bukMW52ttaOP+gLK+hgNFnwat4sBTlQ10UTAqWSJeTaqatrNefNZHXfEAiihgUEViG1Q
VMkXTHdbi4Kzokb0hL6gUlwmp39AJezfFGOtYEHXN7Lv1d3DMAjOI3RfwJB4uyqj6s0Smn0V5Daq
MqQzr0Ilb919pSa6f/9DrW0gyMBEE0YQrcu+sKO9ZbdgCo68hhw6vcPYK7H6TWX6tRUBVgTnAQgq
ZiTkQwd6BvyCqo4692m2G0hB1kFXDOGnFyMY1gH9Ak4K/l1kZR9iNgaicG40rI5M9QBqHlj4P8Rd
KIwgJAT5qyAqlL5MwjIFSvdDE9G0fnKr/FIl/I+pJ3+s0vj00w6CQAzRIDMAzwi6t7eL6fOClpqX
gl89+0epviErMJ3n+/u1/Cq3JqQYlxX92A/gBIrQ7JuGFCK2r1r5dt/G0s3BBuYdUKgF0BRH4HYZ
PEnJ0NqwAcayE7EvTfLWjFc3fjHyg0q7QN040GJbbgtXt/akbbMJQdtMhz0P9Qr1OgcU4sLuSd3S
cFnbO0RDYCBGTR0VJfHnH86aTvF/qOAXUd15PpR/LuBENEHOcH/3llYQDllgg8Cs3ruhWytuVoGk
pZwKSHCZ4TS/DJCl2SwmLT8RjEA0wAOfHMZA5VJw08B5NjaS+7Hh0GxzfHPErMHwN01Aanxtq0NX
5RvrWj5CtyYlv81mnTn9gEw/s5RAG786QOnhQIxbZfvV/QMxKkqlKPcAjnC7fwAWpfYkOEKy0QwL
TEh5YBrYxNCurAbIAwBIEB+jjynTDc81HiFqO6ByqvPAIRqysgJFA/V181Mt3TW89AdLkh+deaHW
zIIlr/+WTldv3FJ6WhoAIguCsAgO0I8DFPN2w3RX0VBQmsmlKY4l7fZzugXPW26WGEcS4E+8qgB/
Si6Ulomh1V3lXZS+DanyNS44hrvLc6nXG65gOdYtsFgAL0ELAwNJSP9uFzNzrW4NoyGAUfwu2c5T
v6LhsecO8XXQC3IdyktnDDsr7vyrRiWhZlHcngyWhtbWAM3yHKKeZaO4CRQvoOnypF6deT03Bk4u
5uyOUe0MechHtAlaTy2O913G8jYLfUh0/NAfBtLSE1/4g2NK2gzQV8oIWiHsULsoRNA0AG3/P3qJ
kYtiPmDQ+bnVv923urJAbLToS4BWEdBhye2ORsU6ZDbKpQYbum5EafxWxlv1paVvR1KIoXCERHjn
0fm7XdpUeYYxgnI9akyy9+zJh0eMZ28/Jz97459PLwiHE80PgRmAjIbkOVyrbYx6iNOIZvxX7vws
tWdaWl/vG1m5bXAaeB7xLlpiPPd2QYYew7d7NI4gve7tciB+MJSLwOW+lZVt8xC1Al8HeCI4GKSl
6Hnf8BkFaSDsrmBieTC6h8x81ooBbIu/7psSEcPt64tMF11tCChA9BfQgdsF6UUCwhqioDjnDrsi
6U4oSBOj22vor+f13+aztNQ4b++D9OIr4VYtGMQThMk88dLIJPPRTHhk1crFA3nG/WXJOygq0ihJ
YFIblWNBzHS7rNSEwFRKexQ202K4NJ3SoG1UlHu1UhAvO7QNMuzGJ8suGLdDsQVTBUJoA/10qWBV
ZHFuIvPMoBFxVrQ30UZif++vSz5/MIH5V8xlgW8buBj5eexI6pQ6TWmUOBjJqab4NbaKrdHs5eZB
HELwC+Ggg0pUbu2ko5t5dGaQ9wVszQWegjh6OA/jv1VK/AyM0vfXJHsisSaAiECFDYCUg2VJ32ow
StVqoZ/udCjLZj4Klqnz474N2ce+23BRM0AdCUdd7iM5vZtmkDaHDHRZB3MNGE71jz09gb/An/ov
ResP7c/PW8Q0L94PhJpI2KTDwAs9LWoXUtp1q/3b9il/yipzfHTtUt01XZudEmLPh6kZuwNtui0W
Lvlai/XiKQG/PEoWYAmRzr86lWrbqhB6Mj1wVmTMPda99Z25464fp4PBz5uBztoOAxcIuUnQZIBk
UXrFppaZqQ56scjlerfDlK8RkJHtTbVxoOpLs8DKjQri0CoBf+rQbdz3ReSABSP3Bh4Zbgz1Oxkx
q/RK704WiLt57yJATZv2YGn5EJgJKrlON9YHldVNSPW6P2q1l01+PGXeqZymHiKtoD0MdcsaXioG
Fce0aKuXvFDTjQLSyuXFTL4jENrvODDJ1w6xRbJCiClOuUPDXDHbn7mltBu1iAVX0/tWADmHrwDq
Hl2ePgJ1WOlqjQvdiTco1WSPwDhWB/sL8XtypXpQT0H9x1CO94/7is8QUHoAHRHD4IpJl9gziKtz
DZ+/1v62w5/kQVfOxWv2dt/KyrG+sSKFombvVAV6PJD8KS9x5w+09jXnCziwGiv31S1qH1t6G/+z
kf9dk3SFLYM5cZ1B6pEV1hSMehuDr8ZSQ5IbPIw7Fu/ur27FEQIfAsoPXF0QvcjBBdQAqeD8ycHe
fZgHvPfnwtzop699JiwL7E6CKwV/262vtXLad7hBOWhK6ySw1My7IhFKztA4c54qPed+3WYbz+La
RwMwBc4QobQQZLy1iapRymiB89iTpzn0fO5r/N+k+Zv9ub99Kx5Ihw8QARNKi0AL3tqZ3aRRnRap
dzcoGCSNY/MFMoIQQiFlE86jYp1QYk0e5kr5BaTsVjts1To0ZTCQgGtgy5w5CsVEOqhwiqiZ6D7J
x9mvmx9OA0x2Gw5K+8q75GdJN07M2glFcI2ao4fyGMY+bpc8mmMD7KqNagOhvuh3TskzaV/d8P7O
rh1MvNDovyCYh4yl+PMPGUqZWswZW5jJ2bkDAY0RX+utNv/aycS45HvzFlOGMpRgNKx+nFVhI/Wd
IwALkxY4rT9WG47qfTzlY8QrbrWJQi2CNWwdENO3i0mH2By9oi6juX5K0xSlIDVolV3WPRuqr5bg
2Kv2RQ8cwU+IGkM6/bHydkTxwtaO/THL/IQYAFYzB8PQ6WM3fteSIxmSc823suG1Xf/4Q8WOfdj1
vsbPH7KujAyd+GhS+xzygLTY+LbLI4RkBlxPEIp4Fz+Rbo3aN/M4U2DD9OGNvhjIs7mWH7OWbD1L
y+WgIC+IK4FrBcOJ7AZY0wPBWKvgeC4qXwNPk6L9avrMV3kVCB4QawSGiCVvGn11VQW5PQUilftD
b+0T5ff9A70SLrgeEEUYHwLzLYZ0pQyrHDEANtsEGJx235checi9A+O/0+KMAGGfsPFYcKibg83M
nX7XVvrcGG0w23/HdH//lyxgC7i2N79E2n9uN7WiQ7opsp2dCZnfQHnsw2E/7PNT8uSeh5PxUg0+
Hfwu39fVA6c+Zi7u/4YF5Fj+DdKzWhvAgLSxgrLy7vsYJgEN/f47e9i6eu/AmNurd7tW6UFNW6Yo
BYP2TRP2obYfInYyQ+2Lt6/OeOvO9Dk988twYUcnfAJj7F452Mf2gLt1iB//HotXiDD67nE4VLsy
LPbp3tlwp8uXCr8P+Q7ugsjfbMnPQeE+a0B+WkYNpe2eGhz333Wg/Jn3/UG1MiOEYjEJy5JtfYKV
WwjLokYCTRi8/pJlg+eZrWcgKKdc8VkNjeegzf2One5/6TUzQjkXrWcAaVHkvHUphYKwQJ0gRKJa
eY7Mh2Oerbq2eRKkW+WYtb2EUKDQM0XCCvGOW1MefLnr1fBeUwuCPgsA0X6IDHIBexowOM0Pi245
GPHj5dMloifBj4v5BHnShrv5DNhUUkZ5c7LUZq+MfxwsLPtJMLhONAyR52CGjSNLO44bY96LOQVx
gz7Ylis2GIAkDEhYqOHwf73k0GkoWsc/cijzkdRvqud++rca9nG/kVFs2pW8B+F1RrMKdqEluXdG
b1d0T1Vy0s4ezlFlBLwH5+P8s3K22pBr3hzKm2hDiu4dSsO3nzfTK+j8zi2uitJmQULLDM131Iy0
rtrqq62dJLRkBfUJQquFDnNiziOGJE1o9Fig9vWSRDn0YMbxHTLyfeWxLMxspwcFYdlsXJf3kFE+
Uh9MyyJHY9HwHNh1KDXZVmBQ882zf7Jxr3nZfjDZSWO2D9ghB7fmqzfvkF+O0znVv01tfiV2e5jZ
E4rzR/3JbpBl3r/KizFcceQ+/jbp0ztmajjgGsGn9866s+u0Y5xgNEXwd+3j+ckLJ+QseL68jdfi
vVG23BQxzQbqCSGedPvpR5s1XlNiU4oXFFJOj+A9J1/tKvgDJasAlRWfBXmo+7X/7UcctAHdYbQk
qIN0H+/Fv6c7xFPhlnrLMvzGbqB2hBK6AEJbkmdjLbM9hY5woOWhh4poNT/yYl/l5SHxm8zzW75F
Dbe8AZgOFB8B6FSU/OQO+aTzSe/B2AY5bajROW18IZ4a+0rSHO9/6aXT/mgIJfvb/c5ao9NNygDl
G9wLoc63GBRerekGrRret2QuPKiwJKDJgswVnbFbSyopRlRRAM7w+uQXqkt9MORFsvHIrhzcWyvS
+el6u0+YPQDN5XgIAhlIbP54UHJGRhfMEMpMrDbU+ktqKKHZQXyitsyN2tzqp0PVG4EoGtwLKnfL
HLkyiR11vDcUalvtCjXs+1u5dFpYJOaN4a8MVBDklzZt3K4k6lhF47PDzk1QWz5PAvKdJht+YJk3
3RoS3/RDluDqTZk5wOBHzMMo/E6pD4O9t76o7ca1X7Xzft9FhRsrurUzU8Nssl7FnjELt+mblr16
XQ957LML8tv7m7d64j/YEt/vw5oSwhq3jmGLgRHICGctCeIm3CyGLH0Gtu6DGfEzPpjJ+lYxiTsB
0OUEse1jXBqYpzgcdzELJ31/f01b+ydlc27stkUxa1Vkp3/dJENh8iVH/U+xN8lttpYlPc1zT4uy
znVAufoKE1zlNXOm1tf1ydeBcB7KPZm1x9mIN6aBthYoftaH3ezGvGxzGwtsuXnNiXl0smFnjUfU
KHzH2MBqrq8RTtdxRI1dpqzttCkGZtqCsekvSX9bOvOtwsdh1Io0cJ4mbdw4kuur+69B6fOVHJiS
ucGmatavDOpSbhN0J2I+2i/3j8m6dwSl6v9fmfT17AGhVQKyuihLo/6rpbhfZgZlzZ9zOxz4ePQQ
t3u0PyFPx1jUxhl9Hz25fdrFjfivcekbgpM315CD1xHg6qWf1h31FYuikt8CaunH9vzd0WY0K4C7
dMKMeiCwNJr0G7HtbGcXWXl2mQJaTwXs3RvbIp6exS+zwbaILAlVBFO6q0XsQd94BMKueEgvTaA4
vvJGn/pXvfD5VlC9akvMaYOPSLBvSK7OMorOS2c8D4l7SM3vRuUbZArs124MmPpDdxHjbGm2rqTg
2HlsPOZiQRSDnOn29ng5XpHOgi9i+1m1QuJ9H5pX3T3YxosyvsX8z9RsvFBiFfKOgtkNgGqUDjEy
Jj3DtaZ1ZCjgZHldPiWed2XaHN7/amu3FP0v4DlEzXnBFzGqOUgLSxdn2TkyuIGxuCT9GIzqE/Qw
/YT9bMyNWvPq9floUrqnBgcFeFYQ7GP/XWVToLUEmYJWg5ERwiWFCk7wbmd64MVPX9zuJZnJZznt
QGMlyBn/Z9HSBfbiJmWpqQDhb+7x9FNqJeB+6nzqFBfUHnd8iwNKvIaLDwncOhB7oCO15EDUVNGT
AIquisz82A8kSIojmjEbz7+4X7IRsFeAehXDK2gfSPH1xMvSnQbMLUzWb2O6kCoOuO3H1uH+iVlJ
aAEXEQtBGQY8FnLcpA5xwtF7Rgga5ztX/+4FuVYFmuWDClk/6L+G6pVB7mHD6trqYA+HFOUKEE5I
fk+dzbpVuFlF8VdFOaOBX/jZFxUkWmW5Mw6zNvnNb5Lum+bQzMFk7rp+y/OuvS+ADJrgPUF735aV
tFVu1tBIcBAvnh8b3/PFP42953+v/L0O0P65/if93ny7v+61IBX655gNwBCvUBa6dTpGPxmj5sDd
58gaWf6Y9qaf1xX06w66ca3jeWOf1+yBYB6lJ1TYcJikQ1SMnTUosVFH7sTeqvbNrNJrmX8v6wTY
ee84dez5/gLXrgayQrxp7z1JGbqm1VZdeVXSRHrrDg+jPvenfHTOeTtrx/uW3klp5AuCWF+koOju
Agl+u5caxWha66RNJL5bfGSn+Bgf29OIOic6leRQnuqTe44v7ESPZkCObXKN80jdTeEYJebGRq8+
Jx9/jbTTWstp6UIYAYNMPyolC4j7PSPXjDiHzlb2dWOds5Ihgth4U1bq6sAafNgF6ensTJeLodAG
8Ndpbxa7oXADxYNE1Bu+sQbZkUYBz+f3ON9rL5DQsqvHNmZBv3WdVm4TYDJgTwYlDuhrZXL6wc5I
WY/4GdQbd2CoydrJ18DBZ0CbalOm+h0jJX161G0BawL3DnpKMrIY6h/MVGyMnF7AtO83X1mEwNdv
99XRwn/++UtDyzPZxWGy/88/aPBnCHgw77SQ+HFgBepOC6ZwRnFE9Y2taEYcPOnXgVXThLIfFPcE
D9HtwaTzUMzdhL0wUe5FyoYGbPqDWwC/OPykZiAG51fFBbkKncPZyo+scTaC9ZWvAXyqQHUingL+
RvKu1MzLwh2LLurHF3HVY7+dT4n2mIHX/v4tXHEwwB7AvwCpKrg9pUuYmonKx2LootF9YMq0M/Jr
p7Kg5Od2OrLkdN/ayqsBa2iH4p2ywCkhXbLMGfV6GHgXddCvOfAdLyCaubGi5U0WjKsYeUPgC3gN
qtu3n8/qqoR2RZ1EefxTz4cdPbpu4EH0JtcdP212Q10/EG3jHi8CN2EUEuLojlqQU17A5xRaehYb
k0ilKg35ALlvZcagkzO09FoWehVgVp4GvdE9dpSnG9X0xXlBfC9KmyDqFSTkMiYxyYnNq0lQC+RF
Fo3gBgioCb1nr3HaczwiVadzX2xkGItwGJGwqNgIIBo6FnIHJptq081LQFUrXQ0aov2YumFrTG5x
PIUNNF+A7RCHVH5vidn1E5jeQTSRhKUVoqXreHuyN/Ofcb3xHq3s4Y0p8ecfsnGDui5UnUGcgKPy
mhqNb89PwDcpjfmklS/378GWLbHsD7YqvS96wzKTqBz8uH7Vv8e/yYBU8P9wFYAjRtFZQ0KBxF+6
b0Ovzq5VajgX2be2t1FCeXCaQ34BJ0h+KRg/TvWf+ytbYqnEF/tgUnrPYn1QQA0iTkU9vYAFBegA
FqSTtbNnBpoI1L9Stu/J9KxOUP5zAm7+KSg93P8Vq/v74UeIKOfD/g4dax1LwborZ1d1e3osro7y
pGx4afG33LwTYqlo5oghQA/5i7TUoct4Pes4MV0y+3nBg9R55qCsu7+WZYImmZEWM1NWlmgb4mB2
B71qoadS+Z6hHLT0Od1dtX5XVi8t90G1ed/wwllLdiU/WunFqEBbDHdP/5O4POSTGYypX7Rb6kL/
ywpBwQP0MRSVZLFpj6sxKzn4DqgLRca0hkoUMog08Hj1qmVaGmBO7IdWz/9WLC0Co/KASE3KL2Bu
tTfe/rU1o8DpgFARr9OCdIC2yQQmMawZsMezlYauO4TeyH1lw87CrwE/AhAS5k8gsSLYtm4PqDMa
BqSUMhVtZTKfLBujC4CaHqbUQ52TcP5Q2ijz55rS7O9/1OX9hGUA5cEbLjiQMXZ1a1lVyjSuII+G
eLMJvEYPVRCuj7333GdVAAqNnT59ge5LwI1TWnUTGJ488HOSbCPPWEb/OrB0In3ErAjeLrlRiJy2
8wZWahFokiD/V0Enz3dGG9DbCeCzBE2XsK9bO3CpMwUzT+vAEyDYIu0p/ifwHcU4/GlSxwx6jZWX
oleB/Fc5f2NjN+71pGh3GD3OT2U7eceySWoovQue9BJSS2WRNQ9uXLHX+5u7eBHFmsCQiY8HYklA
a6W9rVO97vRejYxpfqj15hurja1EZeF0ACrD2UEzEd9OkPbd2qgxrdR7jE8Rjxm7okZNdkARpr8c
vfc2XsSlKQTnSLGFogqoMuUcvzCGtEqMWo8q2kAm2GLzsSt4EZgT2+L8XDMFmAVIETChjvxT3rnS
rrKpgySeZ4X2GHTksDn2tYjQQL+IKgEk6CAFAoS3FFNjgCrBtnpG1Kppc9FZB+jQYNkvZWF0lyzp
bN/ubRZYkx3D8czDljtdern3HwDnIv4f6AIpwGi9vLUMYhgRJK8tMFv5xMt2I/2lmObOm8MOJVLQ
jvi1Ou6HGAiveSP4Xv8BghoSHgDLlQNjt8D4TIGKcdQiz+ynOKT9FORqc3ZM/lVT3xqtOZWOEWWK
+6iOAAuDgPf+BVn5zDoKxLgfDtrOiHBuD2/Tw/48aHB7VTGgi4jMMnNy1wwSQrSt2HHlgws9b2SX
4rqAQfHW2Gg4GST6mBoVKnSv/QwqtL47mKgx0m78OiopCTt9oPvSyfCocK/aWOziLQFduhgKtoQe
CGoZ0k11k0khOE1qNHSad7HmdAhxyrvTPNn5z7JUqg3vI9ZzE44IexicEORS4MhQpWCPaAooPxGp
R2mZ2UdHK8tzTNx87yIme8opKR7QDzAf3cppNpz5MuUCPlTsMzIB5CBIvG63Ws+JO7oDlprraNlW
3vOczV8rBegzFK+tzHtOquRLl1mI9rY0hFZWDdOYggSuAB9afknT2EwmV8GqG7XcVZYVkOFHlYH9
jPq1AwzFpqq5+GzSNt8YFGf8Q2xppARZYA+DXoO5yuYHdem+M4pHkAb7Ztad0yQ9lw1UvpGGbYS1
K9cHvG6gDcE6ETrIpAmcoupoK40e2YVb7HQaawGF1jJOtbUVQS+fMlBaYuIM5xajUwvtgjlNk95o
Sj3aA+Ae3PcCSwQnqv0f/nL5DUvBNDoZc65HoDQHds+H2MPZLe0rJ/lvNe0e2FzuFNqc6iZ9GaE1
qf8ax+Fb5nVhrCqg0Qahh8p9nv3VmzmMx08HgeLngRES24zRDDyBt1/YnW2nziamR0hjAjCnBGnz
MyvHgLZbLmqRp0iWpLPU87gg5QhLDjQggahGj+4pyS9v9/d7xRHdrEe6nWqV2mpjjXpE6bBThyuz
2Z5Yp9rbQoOuGkI9Hh5eSJPIAQMKel4HFhs9KjvvAbpkGaS23NHyLW2j3rFmCA+oiNQBRcbE4u0X
srIJRLyGq0d5lu9K+5+qto+Ymw0V6myc1bV74GK2BM8W+pvoGN1a8ojjDJYZG5GVsfIYO8Ub4ojh
eP8DrbzMQiQeKTr2DcuRiZQ0KKhqcU61CJKHcTC6/Xjqci0G2NTWe79KLR7a9tQdW9epT3Pd9+GM
MPQ6uh57w3DHsLG9y0WjxSk8OSTD8W7KcSxLFHNIWqpGXacDT95xJJ4gn93dX/XSm6HBCTwkiD9Q
C0YF8nZrwS2B1xMfMiqG7MRtqAqx/hTbG0n68n1AAAtXiWkM8DZD2uvWCpsLhaoJ15DRdSErqn1T
W4bf88usTv+QRn82tgbhl4cTc87oE6MGicka+M9biwUGCL0BAxuRWZb8GUQAKEGWxD67ds8jZbSn
Tx9RZFEI3SyIAutYpRTYKm0PaTbeIqxjenlJKruLBjvZZKxaHgpBDYQMHQEGgmg5YctapzJTdTKj
qjCtHTNpdxir+PP3TYxEQi1B3Dm0haVDkSstHZIOVhKzsHZ0wgR81aMl8tmjJyrDsCGYUhGN67ef
iDtFSSZmmGirkSZC6qj9wt33npuu21LbXrp4HGNYQ1nDFqNOkgPpCo2nWZ5ZkQLB6INVF3ix1FI9
FrmOPmk2zF8Tpd96vZdXC0aR5eN5Ad0m+Ihu1zcRhxRlxSwMa5hDsUugSD376jCqpm92VWxtVIqW
RwPNUFA/wOfDSSK5uTVXlXNf87GxIl5AhtAdeL/vO6bsP//R0K5HdwqnDzQI0tHwajrwBmBWsJpC
O54/glTgqGX6hlda+16C3wFZtg7SelleszBBPqKzwo5SN+2CYTDzk50b49ElVXL0GIReGneIw08v
Dd0mEbuDlMQCkYG0gaY9DV5vWhG162HnJsl0QYZYowrmsQ1TK7E6AOiYqEUChvQEyum3tozZoq1J
PCtqXCc/VMUMAuyS2kdba/uoByr3VOZJf5wV2wjMUc8uxTRrWxosKy+ekNtGVRrVU1BQyN37dBpi
dSClHYGGGVkBWJdR+TPLH3Ye2aXmVxoDeCpMhMjNq7OZNKzcDyHEhPE/jB2i7iD+/EMMX4OTJCZc
taKEOimIuJNpZyYz+q22Vm/s96op5NoQZgFaCTnKral4Uhyl7107cu0EikGW0U3jUzanOVjVlGEy
NjCFy6sINj/QAKGJCx4CtPRuzRV5njRmZ9iRUhHyBSC07k89kc9ycoJdGFYQHYAeCv1bmfGq47YC
76raAiXQ/qMPnrHPjYwkPrSF+40LuboixHlQBAPMA62M2xVVjoLJGyV3Io8lGHhD3XCs9mMFOMzG
o7BqCIV0MYstIB7SJdQatEq6AV8Kj3X5NSdOcVQVtd6YJ15OSKDvja4uzh+qEriC0nq6jBhOZack
smKv+u7Vhee7Wac8tmM7nPsRElbxxLVzOUEoC2Maxp6C//7QFUX/0mj5ycyyHOrNJA+dDHx2rjKY
P1VG2besnutHJxnt3dAy+ttp060K1vIo48qIPgc+hQrqACmUEgOtqpV2JHKKmARVjHKqXVivVj5v
fPIVHwVLOF14uxDfWzKmqXemkmJQn0QMz5eGUc4k+W7jrc4xSaak/zaV3Xwxk74ZdoY9JOXepWP1
daCWtrXkBZU2TjoCVITDOBGg3JNHpKpcBzcamB0j4mbZrs7U6UurJB7buZDYazKHHAdNITsK/eyg
HZU2ZDN5SAuvfRyTkV5z6n4128y45HD8T599NFyEL4jHMJKJA+tKV13V+sFjUCyP3N6ev9hxUvlV
EdfPHMWWjauxfBSRzUEKDJSAaCKqMicg60WVq6zpFXPAgV38a0DkrO0hoFgDqbKF7FweM0xHoegA
3gfE7fjX2wsPnHXXW5VTXCv3wQZNvgblROfnZ/dOtBxQHUQVHX5KLgZjKeg3U51eeQlFnmLSfpva
wAM7Rs3qvqVFNgDGczH1AhyJ6M/L0lwG9dAijyuMN+ExfcxpKkqviRPkxMrOuDpbimOLqieyVEzX
iPQbs+fwZbe7l6hOUfUNqwA6UM3XGWWW3QAWCMxSjH84YVYwmozvtMTwXnSQnmzEaMJH3hTHBHAG
YE4VI4XYXxl03DeEGS0bqutAY/OalZyHtT5Nhy5hf6iSpI9VgjmLxKPa6/1tXpxQYRiBLnp2yKIX
4u9GXxgxL7zqOjWDx33DiGtzpxASa/4MooVpDxXj9k9WT/NnbyEMw0HhQUSuh76PdAtTJesGdNjr
KybsoFaGiDLEcUp9Nx/Z4f4al25R2ALmAlyw8MBAXt5+28wqMz03ivpqNSPZlW3tRWxCmKZVmvbE
EzX560Jb4EzYlOUADaX6k+ZN5XHjV6x9Y9EhFUJjcDsLHjQ3Tmo7resr11r71VRUx1ctaN3jv2lg
A3p+zcYZxFFq1b8WVm9B+TGn8/NcsdznHrXPTLGcPSPeL2j9lnvuzfvJbpWAUFb/c/+3LlyJ2DBM
Z4nOD0pgsveu08EC7VhbXynJzDDX3YcSUfahLl3j131Li+ABluCHBaWgAP1acrFfqHzZilVduael
0EYGoz4KDFs6f0tnIm4X0E3g6gJpjBy3pm5HmtRuDHRACaO7ZiiB5nfBM/HMOjUTEkrMmk73V7bc
QzHwj96CEC9BWUPKlZGLzzlutQ1GOh7z17KhU+KXZao0j/VUZVsI+KU5yM6DaAKhK0jjMJd4e8at
3hg563M3oiP4y3cOurbuFQhK1fJTNQGHzIZ/Xn44lIdwo/A3/GdW4tZebbZdo8yuE8U6NVKfqG42
7EvbS7amfdYWhsYboLV4PxH+SZcXR4a3tEzdaAKJXQDAOEDZZUXp60gSKw3uf7S1VX00Jr0CqOAl
VjkgNujb1sX0uAYZhylzP+3tkbqBLQslIQhQAg59u3cukHa8GBQnSptBB0dWO8DZWtrgA1aY+ePo
IFiwmFn5rWFvDa8vHb6gqX7v/AgkhS6dk45kcztaiRdxd9rVA7mkUwp0QPeFD9qhUb58ej8x3YLp
fF2AlRe1ypjN1ZghQoz6Jp8df7bUXAmYa1Nv4zguTgnGBQRcC1YAP0W+c7ulpttoyEFAqa/a9Jg6
eK/1XlNCT9/qm20ZEq7mQwpsN65BSgsc6bkNNsvyb4WxyzrdeCsWxxCrQYYoqNVMtAXkwWdC5g7k
yJjRqWyW7bOq+lKqfbFR4V01gmdRlGtA5yrDsNpEyRXiYhAAOuU09624Tx/UuCzLz94psRiMTAuu
Z+RwC8/k5SgZeZjNmeKUnMbCSwP0lbeGpOVzjVcd3UyEMRa8IBq5krtNWOG2PVKjC6Qha+C/exC+
kCxsHVDfxZ907bBli1wUlVaM9GJ65PYMjPbsWLVFrEuuPrkY/Wl2DmO7+zfnvYz/MSR8NwK2ASAO
UAABjOTWyJzPolLh2Rc1sxUwICfZV2465dcBKdG5mYFtZ8hVzxwD8ofY4GngGp35Te3t+NkGLcCh
VzA+1ppxd8aMZhtMhflvBZZU6I5lZmxvBAxybCN+LDRxkJwLsSkAsG9/LPI7krm8tC/xV6cO99DJ
DIfr8OP+lrz7JmlLUORGWIK5cWy/XAKoDT63bpG7FwSyRTAUXrzPm0bbW4ZZHdARnHbl3DYhmxp3
l7kpfbC7bjoozC5jlAR7cq50twmJUwHO2XUE2Ma0+sLUir14wzQcYVk9cZ6QbNdCeXvHmAaNcXvu
rQ6SgZ1u+wmI/rZKenJsgq3DHAPojh0wlqFuKjkUYxwLPnHbvZj5jMTwoOlQAul/UtQ37m/fliH5
G6kzcB2d414GfgG0ITBGwy/SR7ql17ZqB5OFqBCiqo2m5u1Z4HrJMJYGOw7E2hVuh16Z/qzNJgRT
6v7+klYuPdLD/5qSvP5s9+BBS1z3wrz+iRT2V6fZs/nKLBVTyFuqLVvGpA+lOLTv9QrrolhWvLsq
7cuRbZFtrG2ehwcRVGvIFBaDSyDkTY1hzrxLPvAyGI2iPHVV6x7dWchKzNrX+xsovwHi8AH+galJ
fCpEV1JwpQ5GQrQK5kZwlmJ4sOx3rZ5uTdkvmNDwhBmOoGUG+zMOuoxfoqh5ZZ7TJNEIzasmSK2Y
1OGQsOFbFw9OCYrcUf+nGzvhS/8faV+2G7mObPtFAjQPr5SUk+V02mW7XPUi2FVlSdQ8D19/F31P
753J1Emi+nSj0Y3egCODIoPBiBVrzRm45ad27ntXntQOLP2l0z/3tlzEXgNMPvjaZkWLNDKXqa6B
IW5ePgYzzx7Bd6pofpHqaoj0CcLvv+Sq0cDWOPcNpEbQ9MFzNlGjWtQVuwp+GMwA1SswRKhNAl3I
HaxcAwewAbb6u95v65cBMm07WXElug1bwRG+esliIZHhgiBU/Uoc+RGbqjVpYdt9FNgN6Tb1sSbF
x9x4h/xBJC9wNaENU2x8ADKmoOaVcX1fHmNl7pPQwvR74FBgcgbowTjJTm8wYyoXYI5Sfg41eIE1
is5Y/n3B/0Vx3PV+8GdJhN28OnmXP8XiHok5U20skzGCGMUhlylSO4Dx1a012pjmK7a3j8S6MdBJ
gSEQEDS+Xzt25WzE3RwFSfadMYMM8+cQP2cQ9Bimt9um+Fzya4lZ4woktqA85OELUpdqfVsuUaDQ
2lPDw5QjRY4Fg8pXEcVE+oB2JlS6kBsjpbz8jo5RDqpcWiCozu37PnwNlXQ7xjk+lYAW6wqeBHdg
Cb44uH+RB3ABcnCcMIzzCSAyRbozrHL0Nbwzulorv421Nm/TqZz8TDGijQnJuNMU2xARiO2UjLE9
bEMqq4/yKC1BqSC1rpG5nEKk9Q99wYjpHOsJAOVRxBt/NUeIHw1xC+S/Bku0kQhfLo8eqmaejAkN
YlAf6nslwtzxHv3e/OQclNQz3tvfYehtwsfiD37z7e/P/vZFPvNlGy9oxF98HL6aahZh3CpoTASY
MZJCt8WE/GOpEIdup5HUAnDKVevw/3v6H2uYWrz0dE4AYa81WKvp7ziq90mFOcBF31qGvbGcHBK+
d0Nqe8V3xNLMEnIdsAScdxbNYTYrBLevRgTqEtAKEA7QAOzyRK9LgNJCtC8NTPKgVVHLE64F4wQ9
r6j53re6F1Mg9G6v98rRds5/AncUSgUj8qkB2vR+fo/oqzV3JJS8oZNdTYS0WrkT8KRiwGn0+dgz
/3Kx48nSK7yzaQDy+bH+nMKFRMPPvNVcNXox0l7wxro+5JA7x8qyDgAyB14RaCy0LmvUPg6UJBhs
023sxMNgnW/kH7eXcOUGgiUVzx+8GwHV558ldphEKkUGHQwbg6hufZ+R2o1NUnmtYMNeR0dUzQBb
QC0eIJCrIaxRqmS71DERlY4qm7ggufSSi4xc0QDgwkYXCGkqPhKKdHxLlirtgg4ixBxGfwrCg+k+
mbofeZLXeFRws6x9pHNTbHuelQ5oVnT9kMFUXf6RJDd6LJy7rhG8xK4GVZhDABTbCGrIua50qEw6
t5AGa5NA3dZP2pvs05iQxto81h/ZBJykSMVp7TOd2+NSyLSeDZX2sFcqLYQcPIhgEWUWlTevQ+Wl
V9x5Au1hS6UWVpLFT/wNME6K3zw6f3QBDmAl7QG+HhBIRGTIWuo8c4BkRZoVmkaCWZTvkAI+yVG5
La34yW7STbU4blK0oER7c6JqInbXPCyz9FnLNZH6neCkXQdMvKDwMMTTGrAEuH+5XWqk0ZWVYy7V
elAezFf7t+n9Kj1517gR/n3b2NrWPLfFPaSWaa4cBrdighIVhm5n66OpezJOqSAEr+0WnGdkCHhw
MMnIS6eypI7rzB5pYIIroMBYXG+AIF9EBH7VfmaHAKMSKPhb+BdeHpdmGBwgKtqFgmfWfqQn8wBM
aP6UPw3PSlC7oVdCjmHe9YKItbaKAEtiAh2QfshacF8s1qHpuug6DSK5JxJylWrpCWo0gy5ItVaj
FsP7gVEHsDGNT1ItvOMVbNMkeDM2JoiU78ZTBi7Edo8HkCBqreQN6Jyc2eJuzWqhkwL2MERI12Es
Ay35jiyB4AHiiriv2AJd5giXptiROIuQbSOrHarDSdD6hv9f/XEAp9BRBgIHt9flH5eVQY2jEDMO
Le1OpZKPhCVm3t8fJGBy/zHCeYDXoWIuYPcNYhDRmlUHVrmSpM5j1NiCPbC6VpjfAI85+KMA27l0
R9XryQE/FwXlUU5JI0F+QRpFXZ7V6x7gKyQVmM9HGZ+zMtVl1TQZzuusDtO2iRVck85ieA0AwmhP
2L9mCWTmVmRkfldMjg/mLCoIGddZG8aAAPGDBjqOMt4wl47iOT+Z6B8iDiZG7EmOfde0KsijZe1z
bivDm3S8LW5/xbUoBX0ddIzRk0fmwYXDcNEb8Nyzg0ydLYo1yw6P39SlNBkEzq2EDGQ3gDmwaWg0
hrnb06zkvh6LKAXb22eJ9UNKoDHNoEQEEF5x6cIQ9yGjuO8rnUo0MNTMB0b9EI5GkCmOf3vlVu5p
9tbE+IvC6jx8CIxSqxvyJE2DZHRqH4II0UjmxfmAzGProhkZE2qDIbkr7DHy1GoUQqDW/fz3B3Cf
bpGSBo+bMg1aRX5TJXnby8ZDNku7UIae22TrR2pq3+uo3s19GxG0OIGfpHXm5rSPvSnLZZIAJOzd
Xpa1X4UaG8IO2tyY3eV+VVECi1dQ/Kq4AYPrRP1sebIqQ9DRWdtMaLeh64yyHopE3Fu2plrcA8PG
fG/v6/o91h4UNdk5KNT8vTsQUEIpCshM3A3ckQRdn5nITgZ3NDCo6hgPtj7a+q9bOpA0OrfCB+xe
s8awzdOg901gIOLiRWn/lJixfrntDdv63K2DDhVUfZh2K/BTnDejNjh0bJYskFSncJuhKvEkHf3b
RtZ2wLkRzpnZ6Co9KiEoE2eu5qsFEWRwa38fnGlIewAgQnuKCyR5BPLe1qhwHbRvavZK1V1DP2+7
sLa9mNQxhqeB7ENn6jIQK3UeKopTw0R0zMOnKd33IcgY97etrH0NgGBx2TByMoNXb6j70GjA4p6C
UGqp/mB4rXUNA3POgsC79k5itIv/2OFu6qatoNCmxGlQvWXIBqWYhEpBwiEkYFVwm1rehnl2yKqa
LHOQWfGxUHTBeV27XS9+A/fRyjbrK0vGb0ARrPiNrpX5x/5R3TW2Bwqc+PH2wq7coxheRv0dUC9g
D/jUG6/CpDVGmgalFMxJ/jBlnWu2uzGN/bgSjWatbEcUUFEqQDsQlyiPzO+bRI8sqqRBPi2kMz+j
tiCZZQgO1cqOxAgP0LPo+aOCpnA7cpDqeAybGd/Q/pAzaChEG2fM8BFFeNZVd1AMxnQYEGtgt7rc
+jSy+7qdoByn9A1RGSXhcpgLEeZxZeuzJiqbfmJzlBrnzlgXSUstC2HVNrEbI1dum/9ixfDp0bNm
9J9A1186ko0tjbrWTIO6+ZUsjwOkneelJmnz7fZmW/syGMzD2DS2GhI3bsFAi6YDF+zAFeTB2hgT
HYsGGV8ozQgO8tqnQaBg2E08+BQ+8KHR00yA82aBAbWXXv/ulBGx6N+/7FioYDhetOWQGl4uWzrU
Qwi2LxgxExLZvhM9KPF9nYnQJWxZuKsIrSSG5GLNJCBsL+0YmCqZ2hx22jQkSZL6TZPsU6iidxhO
K6ND3NsHDEJsb3+stSce7GGyBdsCN/rV9FjeN/MyQi8uDtRHTAz0RN4WDzbYVbz+9wDBJ5EU93V5
lOEn/jXIbY9KphiwSpnBZ9XPPOll8Qtf2992a80IQ6cBDYdHEsYKLxczNRY5zwcoxS3KKZ2IBfp3
4P02v/Xq+21Da3EcosWo9AL1jhleHutHqV0Cugj9Npzb3LeLp3QD8SrrdfkTpe4s6lmsna1za9yt
UchVLaFuis04RECVf+hRTwa5dcXFUfaX+O14bokFrLP3+FJGSmxIOlawv1usbDf9xNVYjH5numXq
DuldQjdt5fX1QUQQzULdLcvs1J9ZrkxNyycHCnUmBMCCyW9/tz2xP25/N5ER7rQN0bIkkYXPNrXb
n/Q9/QGBqPDpto218IRBaDydkfwDssLbkJu4d0AvF7Qd/V1i+KZdMM1ktt7/zQxz9Wy9pFae4lnK
mea8sSuKeL9k809Lp6K0ac0dpIBfYHW8MvhACKhbqBXQBgtGTEGTHuM1m3SMWKPBEFXT1m5D3B8A
OQHShxPMXVVAjQAApRQQNNeo6SohBnUhpC64PVbOEiD3eJEBR4rCEJ9BTFHjgKcKMQK1ZTc2QCTQ
qi5ao8DECSytVZYxCYygp6B5jyYNd2wtG0qZEL3IAtof+jYmRndUs+81mPMrIC9+ycNhTj7y6B2t
5xpEhHMnSi9WfWUkPijmMB4d7glCw6bUphHbvZR3Fh5tVbIZw8SNRMnSSk8VT0L0VJD+AbiGmcnL
zRi3OV3wnzwAn/lGdxfvIz9M5A/RULcufHAsor1ye/uvL+6ZSW6zLGk0p/qY5Oh6DBv5MPqyn4D3
m5yUQ72ftoVrCCyuHASmXYIchmm2g/fs0kdFKQ1nkBEawyzfluADQ3dKik+33VoJUOBnYeJxX9+L
Zx7qzQpzHxCKDaCJgdHd7ZIpbqM9duGr1ApgAiuXJdJapkiG+RPGxHnpT1cDn2OkOG0FyG/IkEeU
OA7Nt/msT/uqx3sS7ITtfYIJzP9iJTGLBWY1lGVRUOCuaRRrVDXHvwJLD4bhTx/Q4e8BJBg3Y+o5
KOhZMojTLp3ThrCs4iiOg777qADDlw2MQvaHHKOrDhrRtz/ays5ARRbAEeDf2HgZd87BYQbm42VO
giWu3KI+tJEOGlrBY27lLCM7RAoNAC+e43xddgAyTE0NHf0w/TFfek82Pk0HPY2/R4+wOa9/7XDb
IrFiJIY62mGW8WSGltdL77R8AqhbEB1XdjpiPPoMLDRiD3IJoa0YUzNJdhJMM/VtPBi8xFDQmleQ
fObpz2Wo/lZzFy2iM4vADF/uCb1VtAqjAElQWZmr4/mv0qeizokpZwLfVjfEP77hRXRpKc4qWihF
iJZiGwJKNcpw0HyfekvwSBHZ4WKg09cTowxMgrxGB0+jnpHjGSkiBmFnhcvMkMigbKIDOogCHXeW
ML8WpoZdAETRGNPWUdLdoI2iZ+q6ESATMazDtDi4j5OCv10eKapZ6MIuZvRppfPv26d0Jd7BjX8t
cB9liKK0zxRYSOXWz/R3rWjcRrZ2knIP3gIPTzv3tsE1l/ASRlf+64nP74LeoRgBNmEQrd6HAswI
8ty83jZxvQE0dtsyDnqkTVi8y40Gzp9wUnLEcKmyXbA5k677mES9keuFY0ZADYdaCLbTVULbWunS
o04elFW4yRzjSLWXxNTv4ml6iPMOdC3W7rZb17EO0H5cEOjl4sgipl661YSS7gDDnQcY0iYDLqLp
FNnPA/X/b2a446P3TtZJfQl91NlVOt/qj0t1NEUoOZEz3O2QVGEXN0WFe9b0s8xISNKiwpjXGWmc
P7cduo6pWDfWWEL3DiTGfAKtOlJmU3nMgQh6CJPqtQO3TTW1cIvJN5vebWtr+4JJLnzN7KIBym2+
UO4lZIXIpGOKzn6C4pg0vdZ659ZN94l5J3FR5mq7s9OLlhmyWTakyLPnSWDDn+Sl6iFHQhuvBUTT
A1NXudN6CBLedm7FFHIHpt+LFz56kdzzygK2qpxjZQjSJNTv8yl7m2ikbhbLEKl7X4UJXOmARTCK
DzbKxFcam9BUpboehgAtVU+yKi/OBGURdpVeBPBLCzw2AoI4ZttU8AWnVSJ9L/c+LDabpUi7HcB7
1JXkRt3oRut4UzopL7eX8rrYxOzjikffFMBXg2f2iO1SKZCEDsHwS1cfdXevWATkKUx8eEgg49gK
/L3amF/2UMbAmwvNHX7Oyc5LM61t+Du1bvknBhqq9Koe6jiCa/7quHF22B46e4IPdQgB0UyFnWkT
GZAiU58jr9GOUAwTrODqboT0/H884o6a1utUDR14hB1fv4JYdp/8cfyONH7ivnzKXroRfDORa9z2
j6IkrgcAKIL75dcp9pTDX+OP2NrZEFPA1IOBS4UL8cjYo3assXbLrzKBYkWpev7tRbuKu5wFLrqX
FSqOOdsFrXmXgdY0bA1Qm4Ih+ddtO9cvUc4QF+Axvd2rtaHheCVPtPWS5qTrpNsF4UCqjAyv0fdJ
26bGbxHNk9Awiyxn+68y6mjJIhg2HlSnIrI7buLa/T5uNHlnHH407xURrOnqPjz7auyfn1lcujpV
YgVfrZNfU+1ej14zTUD7IjLBbfUyTOQ5oTpWUzsN08do35eagNPiunrLfTFudwO3uOQ523xpzHRk
PCd29bcKOloeBsOKbagKzu9aiGcaWkB8YDwc0f5y2WKaUA3cq0MgJxORQ1zGmkjMY23Zzk1wLrUx
xqlplIwBtBjHvXmXCC57kQss5p59eSW1CtiACx39qXYPdHj6L07RuQPcezDWFKmt9XgMQlQfqj0G
B+r4qL2Pz8O9fZTvXpIH6maPt40KFo2neM+6CNBZKxqDrKi9UqndEvjEwhTgtlatgG8DRIes2mKz
f362dFUC7oGswKeB0p9KAAQQ6aeu3XcgmfrHALe9QKIzZm2XjkHxG9gNlxrPbb4dBr9JtrqoFbEa
dPBEs0D7hGYfyGEuvYmLLFTBJDQGs/JTZjTkG1SoSEw+M9d29Z/4SIJMbC17+ccgm5HmDA7pBJEK
ZtCtNFeGBudHB5aW0asWVMgE23x9Kf/HOxi7upb6dLRpOaKQOX86hEyf73+/G0CEhDcu5jGQHvM5
ut1bI4bZsOeq5rGgz1l8P9Pn29t6xYkLE9yFVJZVZaUgOw1U5UeZ/cZxrcuHFvP/J6UUHNuVS/bC
FAsbZ3tb7StMHdfOEORZi0LHu2b/mGxItYveoOt20OxFKxYkGzw5KQtu46DhDGELOKPtFjYKeTJm
mhzRDljJfODRv5a4QMcYMJTZwmHqSupCHonoheRDp1QKJyJSZF0JqiCNtlFSwQA1hFG4FCWSZ3W2
q2wExr0nhb6QEdWv23thdeFUQPPYMxp8hlzwMRRt6dIKG3qUD3kdbUCZSHRzp0/57rahtXVj0jmg
kf/qy3M7wa4nY9SzfsLQf0+SaZ9V3+3iB6uvKf3f5/coj6M9z/QjGA7kctNlJR2TRCsn4OSH51Yi
heJX0MwtSPrX0CQQ6Z1b4pxSaRmNst5OARQPwESl0djtm0L0kF7LR74ow1BeQ+cQifGlQ6B7iiwj
Gaag01wI5PphuZWl3WSSJdvW+1I0nbsWHxhD2X/McdtutHOrlCZ8qlhL78zfkhp5yfxdjXxF2QJl
LBiwWLn+LpzjvtaMuqQzpXDOGKiXlzLJw8dBxH0oXELuSzXTNDqz1k0gWjxiuMx0LccdjnJ+H7dE
GnxJUHn9ev9zb+oLr7hzNYaKOY4G1rD0h03r0ofyxTrWXkg6ogDIHpPfYJO9dwSHbOUuhFUUP4B6
QZDiZ1UaBQAASDZNwVzfJWFDwFxD7PpHA/bP8DcUDPRe1NpbOdbon6C3AYo5cNzzo85L3aRZX4zY
ml59X5H3g+h6X4mBFwa4eAsGzkGSkmkKRu2+BFq4Cf9+zS4McAmLVtqZrPfwwEwhiJlSF93XEJIe
ILdmOneUVJFolHply5+b5Asu01gvaS/BpFLjujLuocleoDJ/O+Be4xkZc+i/n4Z/Qs9RFjqVjoPV
eMpGe9M23UdgHOa3DtKPYJ38ftvcNRfHlzmU55HHYqifT/y6Ru9yfcSOH934NG6HPTI/ohNj24L9
Q/cSP7prt41fBsdlQhTDQPA+98rN79s/Y+2gw+v//AyHTwcp6KftCvW+IKX7AUibRTNRcGz9oYd2
H/Vk3D7W4gKm+Hrb8ErQvLDLxeg5k5s0GuB+tq+eRz/80QfVkyzYq2vZ9YUVLjQDrkVBzocLx26D
rPVAJ6yOCSty/qz7Ny0pfXkySOl86KlB5sEmtkrG9G+ZeFGhu/gRXMSG5LpdGz1cfT65IvITwTaC
KNzlXReWRaPaJv54pOoYmbLv9VT1zPi+g6tUcluwcC2WF+ZPdexr0zN479qKAJObOa6M4le/HepN
OYR7Pa2Aydzay6Zzji1klG9/7vW4B/QsU2kw0ZC//JlA6w1z5+AI9/K2nTwg8VoHQwx+KOpKigyx
f36WQTcmtRtMReAUb0aJ7A/9zhCkS//LpvrXFy7ESpM6APOLI9N5eB3i1Cobiyhe/A7uvfjRQ1nM
vb1464cULC0AnmA8ARpOl07ZStTrGO+fggQI6ymrSANsS4ZWf2641kSG8EihbZj8NeEN27hnZrlQ
j77hbOQx1nKSvzlRSbLvkR4CIyw6pavx/R87eCZeuheDFUludNjRnHc722YnadjOL2n7tYPjH0P0
s/WqQSNLp+K/E1c02LaSBlhgZEUCABg09IE5+2plRDQzsbx2Agm1RPLH6lPTjM0itRChHzbS9CKF
ol3ETj2X8VwY5QJg1o+glc5gFOWMR1sqXQO0LbQ8gHDFMO6iwbXVV93K9jLOa1z48VIKcq5rugn2
eRHeATKyUBFwuNChLHY9qouC0G/kxVbrnnst9buw/anUG10e/N6a9/VYk0jz4hSwxaa6A33qEEuu
Gpf7NLprlp+Wc99n4SGPBNfD9YAm9+P4hLChkQROL8Q109gYYe51zinst9rkhc09GOrjJ2XeV6gJ
3z5q7CRdfRVQLjN4P1aHZ0op8jIPAeSFWeihLNEWL4gsj+4byXlfJgOyjJKgfrHu6JlFbh9oc6w2
Sw+Lxjdp9xwCbzUd1FPtOftEkHKsB64zU/xtmCcgaZ9gqs2hdf6M2RPP2B59vIu22TEI/dtLuR61
zsxx915RQw8MHaUpkBRvXlxl8cAO/ynlXvVYuPFWYG3lZY7v9e+X43ZzbDtpAoKCKagKAyRk/S6q
Xc1QiRGYdBvH962u4B+9ajIU7lAWiCTSpPthwXXU/PWwGtu7wENiF+Hul3Xuk5qLJZVVpOKn9Ft1
uDfU50oTbJvrfYr5QBDsAPAD2DSeEpchs2yrSYtKZQ7esk3nIyKKEovrmAgDGAuAaDb+B0RsLg0s
c6slcwUDEL14ltBURE8uX0Cw6dd1ieLKD7UaBLnoqk8g80Qfi7FI82Nk4SwP3RJpc6C9jROZqAua
sFP/QEU1nK+JhstDDpfODHHfR5U7XcY7emb1AdXtPqKJaLv5VfMUkhwsf/KTfbv50/iWSSCn1njO
afz4Jipjr3sLzVmMe+Iy4SHvqGeak9FggVUTqM7G1e8kLxQkDtdnAo6yWXrIv+Dv8XT2Tli3hZmZ
cwAhmxBFApD3KdRrhaQEq76c2eHOXgrq3KXRjTmgz7JJimYrYbb5eyM/gu9N4NIXP8rVxzuzxV0M
kpIlVSdbczBtUmL73abz9C0okA62Ox/J4hq+w/7tNn6BiYV0WyG+HQpywEwwQSIszMCvk5fLNeYy
2zp1ylTJbfwePJUyugnNllgir696/kC/oUkAwSDMl7BCN2cFkgsg8e278hiPKM0pezM+2PAHdPgS
vVfCb5N5alLkCaQcBJHmKox/mYZiCdJPIKNUHl7qLEWvlFJdHsNlD85TL3/JZNKU2659seRTEwYT
PQliOZ/Ew6QBVAq42hgJImbzL4OP1abVaMdmdUzel01x+pDc8QSqOty/RPXUO7ffZS8Q2BZdWPw2
5s1ybwe5Tex+plZ1nPt3qIMPKuRBMwDa/VYKlnJn4pn6S6Vb3b4fH+bUeRlsd5p+WJDXNEXCPFeM
f/xvYb/17B3TTVGnY4ijOko7sCtt6CZ9UffJdrpz/DRzO+qyLn9IYh9alwQj4hGRZdf2y++6kDOP
vwr4n8LdNctcRbNc4WtALQ2UeeVCFJK7xW5w5Tfnvg7o7nNXuNLJ9pX97Y2w+kHY1BhowAF54QeQ
qFqDYaIoqmNZAZBpDG46R246bQCmVqMKien8l+nfl6tswgCUDSCZN7hVH+cuYp3f6tgab0gmXHm8
p2HkUfPYliPBaPtt//j4zMyBaRfDhAwhDNT45UeurUUK516tjgBSH9Ow2EphDS0Nl/aOIGyunWIA
uEE7BYZF8MvxCcOiybmSNEl9BP0IZENQYSrIS/SgCuAGGnsrnYfnL5f+tcMTq0SmFisLhZ1hkz13
z8tbjd1CHyS/9oY7KCP40Ta6jze2F24m930m0bfYt3f5ptj2H9E3Z99sbi8xu3qufw8jTwYpESME
vVxi2QRrgFTn9bGpqFuiBzWKpuzXLOD6Bn02QiQAz9zlpwLbPxlaUR/bJFfuJsuOfWr1scCPr8FS
3hGmGqdhAhkshDwDglNWg9LUXX2s9mANw1xIupN93TfuJhJgim23+NlT5b6MnrV9yVxRCXbdyX+t
cxG5dJDRFmoP6zZGavOiUk5qnIhIqq5oh9juOXeS+1q6MeYNGBjqo3pA1vmW7BQiyYR6W8WFZt4m
oaT8IXgGr3oGKC477jgWPBy7KQb0WtO5PqZL5TX5nYNJx9tb8Ord9eXVmQkuZTEAZrO7dKqPzk49
0F9zTcIfptf4baD44Z35EXlClrm1GxRikP94xX2vBbSISdnCq3hv/NLesKCvIGX+KO6S/ZwQ50Cf
7E3sO57zLPB17fwD54mVNHDoAMC8PG9JBJR27OD8GwWGl1q3eshCT+62zraI7hW5gOaUCBi+GtuA
ZAXZAd5daDXz6wsojZ22tD4iFXRVf3PKjg05iF5EVz2qr8/IhungH3p9PLI0m/pQ0uaxPmrE3Ka7
bCP5yIRi8E4GGpLL/k77zTpVn1QEjLxqTXCWvxbgLBlo8mKGnCMsGw+T1+wnYjxld/rD4r47Xn9n
Cb4hn9GCXgzyCpAUQbgEZpfnIjeqsq/aAiET4k+l21gQ5TONGaQ3wEB4t7fL1VOMt8VduCBPBjtu
lNbHfHrO6e8/8894cDtP6u5A0E5s/aHNI7d6DAsv7zDw90B/4r/nj2Y6DC/Rvp03WaSKrkqR/1y+
MzZ9BE02/CZTe5siT7H2sfJNin/US+zKMUHVIN1Sy4tyV5q3y+haiiDWX9WELlflarQGaj8T2A3w
C7rxM9yF4Wc+YxDqYdFGr102hvVaLq9KLaIeuooZUAAA1N2ABARSkSsOeq2Su2Qw+/5oj7lfmY+D
clDBLZ1N0MqOft/+8FdrDP4TsBuYKoLEF387FyYsra9r02yOdZ69VWm0KSrVbfv+9bYZFuYuLk2Y
+eKDAMSFUYdxkaEAiMLIFphp58gvtW+JUUE89n6cRQ+0NX/ODXHxNm2xtHkPQyOqPbSsXDt37he9
FCzbij+4H/G3HABdAKXgEkZLB19X3iTwpzqyOTw7frGqTYnBtdvrtrIVsBEYfh7D+CjIc1FcSfSU
6uPcHOdXPSO625xq3e+dzW0rK4t2YYU7/JUJVuxSX5qjBS3Olp4SHwoIAk+uzxLYx5D0giYGlX0U
QtTLndbRrEL1hbZHyCTN9+VQawWBgNTg4V3jldQwgUoKU7ca0tp1QG5OplZK/aFLc4G3a2uKqXt0
bzBHhHFULqzI+dCMkICuj7I1kMzQt3LyK9ULN7QSD2N0Ar+vIyv8xmWlY/oQ03BAWV36TQs6qpkd
NZhW+bFEvzBhC1yup6kBeCOXQBvLnVSdsjJ+maqN83PsUOvOvVk5xgA7Q9xA713TggR4hT7TgzNZ
IqKOq+4DY4VDRQrTv5Ci0K+2cgq95UIe7frYN86ug2iK+StG70PTfioH2rrpc2WRWNtJ8gHadRtb
21fTfRtbWzv0Z/2+cUicvd7ejvp1sMAQDAjbASt1ZHTlL1es75e0m2wLOe5cf6+hstKluiDZXNnx
oAAEoQ/zHELQ3B4A5DSeirHujhWq4WpymCJ02U1BkFjZaIwsgYnSYVrj6vAmfWsBMNF2xzI9KMtn
7TgepQ6aNgsBV4OAgmklIl0Y485wBoYLszCb7mg0NnjlH+Lq11D9SUwBxpz9GS6Q45vgWgL3EuRL
ed7+UaunoYnL/mh2H5KGwh/TZ4xQ3VfvVfnFiFP/9l64fm7hMQBaSJmxPYEOjuff0cYIw63m2B9j
G60x6iu47z2jfes6lWjokEOsGDx3/vyrfJbv0n357AwvTnrATj2ad62+u/1zrvcNKKdAaoPxji/Y
M9u6ZwlgloOAL9OT/pgXpw4cVzlIK/+WmYKxDaK8CJY9MPdCmpjb/iBfzaRcK/pjA9KLJHooStSZ
BsGU/PXe/JoiZx8RzGQYSbx0pCpks6VAuR6BM8D7oCCR7ichUUXP5ev9cmmHLejZgqHFYLR6Bzv2
jOoZBobpFrP4wwLROsGRvo4azBLONN7mKp4F/LJpo145tAPjhWbGbqdMD2pRiqL5ijuQJMVsD5h/
8ajiCSHaOooWoAOGY+FtwBuD14aIEZdFnssDpl9Y4NzozdqhsQELBuAMQO67yd7ePIrUWb5wHrwZ
lJJBOfY1388HwMRyyqbX6HDM9Px+fDZHZPDd3mlAgZ685PHj0ldvkC/cz214yBZ/Du/DSd+0oH3p
NT96jit/hFhedl8WrlZ/K5MyMJds45REEvHOrHxXwLIsJKggUEE6zIECoBej4HFSD8fQbqV9lw2J
P7Tzn9vn+mtU5Xo9/rXC3dLghp2aam6HY77c9yD30F3oVEGX/D0+6fnkGg/RWNTgWDhNcvFafZrx
hi5+pGaC+LLiLMbqv8QPoSZ5pZU1lGZY2UU7H6lqEmfoiSFw9Ep9GtEFFhBTkVGCYZOHuw0Y2JYr
kEmhIFEggr6lT/S5fwWG5gTepa3pZSQ6JSc79uIFLMwq+W36t5eanXhupQ3M+6ETxtJACMBcRgQp
TscU3DTzsYWYlZnHEC+9w5iHd9vK9XUINxm5IwYScPXyZGpmVublMoXzUSmmnUnRsxgttyi+q6KC
3JW8GVtQpiQAknWw0IFN8tKfsStMuWub5TiDH2baa3fVt8hX95M7eoU/380kOUXuJ90u3257uLaO
53bZPz+LrEme9IUs1cvxzTuJXt5st/Pf6Pxvs9U9+9u6SjuVNvjbDtG3H8NdRwCGcR9TdPpuO7GS
HV+uHvfAmRtLggobLM3uR76lXnlv7/V9sVu27Vvrvbe7eSttzCOq0mR0Gy/0S8GJWzkQSMuBGke3
ARw/CDCXvi72YhX1WKrHaR5Tt7AgASp9p3JC9D8GpHx7V+oa1wpHkj2V6mvTbsom3qTF+JBAFclC
kbIyl90AxZPZV23B8lxfN6Bhg6As9hgmfq+mSZs4B3VUpOjHRcowS7ooureoZrzLpmqAJF5ubiQT
DO0y1czt7Q+zbhk5MhBJUCXia0+WDYU9MIvoR6hokTFTSWHnRJ620b5s3xJbEey467hn40kGHgvQ
SiH356MSAGFUWijVj0lj3htStemkRJDxrGSSNt5hKKchIUd1myelxPRLjp6iox+72K9ONETXdr8A
arrN/2RH8I0dVYmkwJ0GTe5p+gb0w0Q5KZvEU9xBWEm8jk+XP4bbdTR0ijwNQeI8P8q1W5t3iu5a
yMISFzMmbb+zN3n9vLxOUBHGLPvGEc2aXBdRQTcKwTl0oRiREJLry21fAnM2a5AhPda6dAeaFU15
TO5Cq3ipqErM/oABLrU/pPbB+H+cXddu68qy/CICzEO+DoOiaUu2bHm9EE6LOWd+/S36XJwtjQgR
Zy8DOwJuTurp6a6uEgA81gyg8EPlM2yO3ef9nXZbqfr9Ely9Ii8jXc1mjTmlIIU6hopDvrTYlHIq
18fIe+SM4EkJHhPFarhVUjwUO3Hrb8F6fVAfy218HH8E1xKp+CaQdYpU+lrSjBxnZOEiuY3HNFxS
oLtDhxZAnxKzUBEo2tFyja8b6q8mT2mtHxLp71+5NcuCw7P87f5s3NYoMBuX9piXKSfDGakJ7PXt
imy7vaNvXXr6cJ6/Fwb2ixy6dvKwhJ4wzDnAKUjLXO8AL4k7MYWQkCM9gmpWq2j91I+2dwzQQ2Cr
wLWuIEvW9UcPGA4QSe+KV12wRYhhAm3YPnD2KFtiDeaIg6KuUw7YeG+0CptbBfIS39vtVXf9pUzI
UEdl3RI1UZxEa6ladBSktYq8BHa4vfRgBdkQFDDgJtC9dj0fog+NOFJ1iuNCqq8cqS7jFXEMRAUc
IyWV0V8Gqjk9iuyliOgWVDKtOWJcqMoKUKBhZd11pcqGhGsVJyi+lB0HZXfBTCt0cFNpWNfB46Ci
qsEfx2BhyLPzemGX8QHK4AqQBK0VeL7XMnhJseL5v1o7sNoC6KVNQScTvpd1xw1RNipOE9TOSECy
pNUrSekXXn+371lM4YUZZjOjWOiret8rjhIrK6WL0Sg15F8lkrKx3iZWAH7qhStr5oacLiqIHWDt
QB/FxF9CUrhQHeAVJ87fo3IX1HYVKccS90rHBWu/56z7nmFuhCqgjMgjIh8C9P719gT3B5FGgHCd
rk+p7L0pYrcK3WcoiNO+XNKZn1ae9Q3I0/NIwSF4RqfAtbEkKPsAtIiKoyEDDu1TnVhZmpIFFzQT
/f3SIU1PaXhYWZzGfBFn+g2nNCk44Rw1RoO61hlKdEziV9C0UV4GVz5gxpbOU/Q3tVZKRhScotQu
9E3dGFpg69J7CLBVDWX4BmS1SwmF2YABRKcaJgKyejczrjRoXxUjVXbSMN7WhUbdZJK3o12eUF8V
KQFQXHE5w3XdzBg/YsAym2qVCIYkvXj6OlfedJm6z9ARaZt9DA7k+xvitkgPtwFW8t9uUdzhLBIB
TMe11IE3yRGGkiqAUKJVuazWrolOsA8XGqPQJDoGTx2nmQN/gkbEffuzG/LCPLNHoFYiS9juCE77
pKC1P3RWEBaFWXkBmmMVFdgItC4uDHpuY068o//B3IIn+3rH8HlNOjLg0nLFqloB0BOa8qDH9sLQ
pm9n9z+Aw7j38YqEmCLjTkguqeiVlhArviDCtyyZHnVjf/So/Uen9tcqoA+8scG/EoczDcvab9+s
H/qx/zg9NzvgZb99ul0/W6v9+3p9WK/PL38Pz68ZNXem55x3W9fYHZYgU3PLcfnJzCWZa11bVwN2
az3WRh+eyLDroCLcCo8C4Br352c2Srk0xtyVbuKNlTbIsiOprZWXWwAeRXKSU1v45NC0IFvJSdpq
+zDfudpS/X9yrPfWhrm1UNmRqjDF2kjxu4zkZVeazVLU90sUfs/I9BEXnslz+TyveyI7u3NGe3sw
8PrB+z6j4ireEFpQ0YosCKeZxHiC+Eq9rfZ4HhNTMZeeyHMBKDRPsemnTDhk4a+/JJIbSYoj3DPe
8Cfr1+10T3u0Hh+DascrdpkuMQnPHbFJIQClKvRsA559bbCotYIrA0DtCpenSrT1/IUawu/bgp1c
JGnhuyCzgZifGRIQBSlgXLHq2JsNZ2xeRvqjmjL9IhYxflzz5ymAEr1KrRAojuc12cTn14SiMfD4
rZ7ub+S5c375JYwP04ZeFsd2GquyGxxX6vAC+wMgxMJF97tI90bMXHSV6vlDSjDihA7bhJ7POv18
/KygQlbuz5/2y0YzfxLDAyJQN56+ujP0O2hOkWAGtYr94UOhLLIPu8xqdq/N/8wADHilihboSYAN
bSBItF4v+Fj4Whrkjeq0Lpiwh20rrTNIm/6Lmb4wwswAp9Sl7ouV6vTwFRoQloJGmwAI7Y/7dmZ3
74Ud5oKAnJwr1DUG03h9ajSkamlaRMNC8Dft0Jv1VMGOO11EIDBjfBBfaqk+tr3qTJ0tOuh+h7Ug
LSUJ5iJMHUsC3DV4129oNLokaz0/BW/PoAEy+Vo+y/mJ9BxCI9RsPu9P2+xBuLDFOHSRdxW5DBPV
8fTd+MWHZl6UhlAtBc1zzgx9/r8lZ/APKszJF9qmK1W/UJ08p10obaqKNwa/MPv+gGCqRzFR14/3
RzZzL2Kd8LydNJGBP2B2t5anoZfHkuroyjDsNMEvrDoQVmOuPlTIEhnFGCxYnNmCYBXgAXVFG+OE
J74+T/ogk8Tj4FSkUngTQmR42url/qBmluvKBJMlIEEmpnwDfyJEMpUA65WRNhntJMnM+4ZmNjqo
TyZOHzAUAWrHbPQYugI15C3gIItvIEP8AjIr/f/IpAH/c2WD2RQjukg8UsJGHf3BWBqyFvoFOPTs
fCGZKSuTBiCCN2ZJ1KGNIfQH7xOrKW3H4UVV8cSXuSqmEdo47k/a3JZTII82kXmC+JKVFhY9tC9W
Y6c6nJj5VutnEkWTZwSqPp9fKUngr5rMXzjA8vSQZlwS0sQTsyzgBhC6Zx7aTe76jZDwGKKd0AdC
CX0NV6+l2VkZwpUA4saPHv0h1ur49PT+pJlHOtgp3QuGaBodFen6b0eXYpfZibj4JiaUSDiACuMY
brLQ65c66DUj0prULFCIkfWBtkq+RJA+t18vZ0G8Xuiw1FTBzzELWvoslcdQ3MTBQiPOrAm4E3A1
4Fxgja9NdGmfqBxq6o48Pnbe81ig70NbON/TsbpZzAsbjNPSvarkglqGnxy7r16ov7hFdnd1mop7
NpgzUUt82SCTj5aK7bB9rSy8qY0aewevafxEtDzvNKPZniVa2giCX34yg5s2FvRgJu3UzDj+bI44
PhsVDUGBIVNQmBmuT3v8Y2lFm/AVYtr0rTUqm/J0rZiHf7O9IPY7JUUgN4W+rOuVaCv0qg8ZwWIr
nmyLXqyuvCQ754O6ERsxeVTRM7XgD+ccycSjNaGlUJ5lpeMQp0dCR2LiKOQ0xBu8gDKwBIsQkbnv
QuY2GfJKYKMDRA0kWoyDT4Zm6EohIAhj0MLAp1Jmxi2q712lLXXdzx3Sf0yhWHo9i3GqlIWicNjP
VfkMhspXuRffSCDUdOIdMPymb+37g/vN67BbD+VtSKEidTblPK9NerEGm0FCnHNtTkBq+Cqkc8zY
CPHOQreXET+C3oi26CnUrM44i5ZAkZKGcoN1/0tmp3niLkRXHzRT2MamVFGKPpZL4ujcllMPPP+j
I/a5b2N2fgFLUVVk2icpsevBcgSa362XgUbJH0OwCahPVYYTpijIKUtP45I4++yQIKeLmrcKMiWW
SwngglEM3Jo4MtR0FfSjZdpHPZ7uj0mcPQeo2IC1APLiEJ2/HhQZfJkLhoY4pTtQv9tBsLfFvT38
7esn6A60mq1raI7knwoVGTp5VTRG7O7SsaLpOuCOfRtR1Dloz3l0cLsHzwd5UWxWzRO/BD2+7UpA
eAGILoJbyFkDdcB8ageaxQoqv8Rx/QRQccn2612Hh563EWtTEQwV7RlGJeqr+1M0tw4glkA5YcIA
Kmy+tuwkbYxiiThCBwkeQuoDx6UJSFh5caGy+VuZYI/TpSnGD5Yd+gS4EKYao7V7/Cgolg9GRpGu
QIsSUGTHdNObCZ6bBX1EGNDTyPD2rTWidzGmT97qx7PoPsAsUF83/O3h0Bj6v4jyQAvAA9EJbCfa
8q93DBLoqRKnAnGCUX1BEPSilgQK5r3IL5y3m87kKZ4kCPZVALVQ2WKRxv4Y5/GQ6PDRuKniTURb
EEkNVkUfUcZaC+ZjQH9a+hXTfbbJKTRiQCzVoQUIvo5i4Pe3we/74mZxLr6GeVkJRZr7uYevQf83
lRtTPw/ZN9etlHrlpjs1cUK/MiQVOTsd/TmfnAD4fUbLajNkltyJRjv2dlBpVCgAy+Z2urQBbtnM
1d1QraVwp4V4TkdGXUdUUs6Cv016aNFHj1VjV5yRd3j9GqpGeSdQUcFKKrNTXSp5GyUfDLVdGizW
8N5Yp7DmImvGhX3djz2BV2jRbBhYBVo370/nnN9BqRj16ulNh/zstYUqinKccU9zSP9UjyKNgxdN
So2sWbii5jI2aNqSUG7BGQYAgzlTQEqDKzzFspU4Nxk9J9hFBLERanIUt9JqgIa8ZKsGNtPR3XvW
z5dGv75kCqoCHCxQQfBfU/gzoDX+EJnIRFAzNJYKKDMZgonJCVcXyoeqxCqhtoVYE8kPNUfyPvjh
I+0rCt2tIv3QlcKStcS6P/nS7Oxf2GOusrDoC6nOYY9AptR7cCW7iNdq1TnEx62dFxRYBsjRy7Gp
Q1GvM/TedtONj6BQHQ61GNGq7I1YsKRBwgbc4W1uuMiaJs9VYcbC+yAYI+heEg7EWMe4fdXaZ6hH
KmO0jrilzorZa2Gat6mJA5gQFsrZN13mFUqiOfFG699dyET5KDZt5DXUAEfZ6Z/uz91cyhykRv/Y
Y2Ien0Sq7hew19a1MWbJm6K/8Y1vqI9KZnj6IdcKmqU6HQNLjQ6SQF1lpAvfMK0Pez4vv4H1RT6I
CqZuBKd3H3nfcNNnIgKgVlIimLq+QveHKB8QwRgSscfE8LveIvwHH5TH0l/nvkuFxa7d2U+a+kFQ
eAfVAKsMVvM+XwYRtlSH9XekAhmg7CvPDVXdxt66WKTwmhzEzRTAHLAviPeQ7bx2IEWVp1zm5ZqT
KGiLtJQnBdgzx+vfC6NOKjoWdpVt7k/7XCERtf3/2mRr4Miy567qZZh2IKAzw7d9o19z0HXr6ZNG
31L4iRIk7QN1HTRim8lCbfy2bREX4qV9xmkOalH51WRf6W1o5u7aHJy/SWugjU2tVv5QGXX1KIVo
J97JolllS42hcxHwpX1m6ze9F9ZKB/uFnm8l7qxJBuE3vIT+SdD23p/s2f2EyBcCLsBwoLpwvb6h
7CuD5pY41oNA/SQ09MqMEZGGZMepT6JUGNFSsWjelVzYZK69WMqlUgJw15EkS151JDEIJheFYCAf
qFq/5SfB/Xt/mHPRJWrveB5C4g59EcwwNSUsJE7rNCdQeLNOzzzQOFn0ct/I7LohVysidsZTVGTG
NZSNIGelRpwwTIxAXLtdbBLXquXK4LyF/pXfl/PNwcQZAfwZGbobbj2Va4FXr+AI0P1thptww4MT
CAeSelRGlcijLzruYV/EPZzR0eToJ6pga3X/lO07833CSLk02exPHf2ODfBaIedQoooi2qfv+7My
u8PwlkPiARNz8172OVWs0g6OXPFTR3Oxg4doF4HUh6h2NPR/ohJUben5vtG5mx6CU0AZAw4KRAYT
jvBC1oBMAka1SqJphGhkn6waXTeaDDGJcLpvbXZ3XVhjMthFXUZhoWBDq3CJufgpi98DXmv3jcy+
IRGpo70R8hHYx8weHvQkSkXOh+vnXpOmorH62VabpnvxvHNcryGD3gDYB2Z8iTyEqZMI6x66pgmf
AQvyGeoPw0QU0IzoQ86tUsrfaq9eQRsg11Z5t77/rTMnARECWH8g4woOlN/k60VgG8nS6HcDpt+r
Bqr277J7ROcgjbqnMiQL8zLTiwA4HuDkAOehtKSzL6VIJ0Omx5MLQ6CPuKRY+/5qJOuhlGnY+8Ao
g4ExMiMk6Vraj/iPIvXCF6VbOP6zfm3CBoKeHqxVIkuy7gkQRsm5VnMEz/IVK8tWybEpDQWJBR/Q
aOFYLV3Pc9v80uIUgF7MM0lkLwz9ya0FeKt7I/fupZGVuTV6vL7KqDt3CEnuL+2SSeZkNW7WhPEA
k0MUWaOMuL5+6ePHDF3KXtxZMqcseLolg9P/vxhjguGNVdtPBrdgbKyCfeR+F96RBKqZBu36/vDm
vBUqbnguATug31QqlUaUqhIZHCdRkfwod4K2Bh+rChRjRgXt3HDGfXuzuT10YANDCVCXhhTp9fC6
soPwKlozHBEQGW3b49XkrfMnyRbgs/+Ato6qULWFcfoSgTyppS+VAWZcvrbSeGFpZ54rGlJUkEOe
+ltB2HL9KYLXDpB5Q34YG9ki3qeYV+uaaDTrlriZ5vzDpSVmTWMuj8G1AUux+6fmoRuCt5CgNWYc
ITvGLSzp7LBkqB6gew+XPzvDXut7Rdj6xEHxCRFUaMuiRys1MwR+KTf8C3RibmVwD04NLsCfoKQ5
3RQXmzXK29ErioBM6JMg3KARYCQbNfsazZZ7B/F45OdmdGo4Wn8Owj6oBgM8EIDDNBuQHA/qSoyW
KpJzXgmfBOgbcklwyiw2C0RvZQqBcOIkHVQsxlMpHGXN8tU/OZdsSPYEPsZXSXq7v61nF/jCKBPC
RqgtqH0Koy18Ltf/ALlo1tlPgz4R1C8XboDpiNxMOi5EFFxx4yNzfD3pPCepadDAGB8kohHHQBBy
cbHE+TG7jS6sMKejGYOYb8ccCTlhOySoxKEa1KILvotoMCwBJmba/zXwwuBeA88WRIXZtHQHtYQa
VzfSYOeaNz9HD9T+IN0J99oRalsLCKPZoWHqcEbw4iY3pJlCEcZpWCGtH75rNZy4/FlVbyK3BGqZ
WyhIlPIAzky90DcBMgliqU0G4vTaSzA6Wv39v++6CWH7Gw9rMtsJX5LWrdEdQRzovVGleO9BAqGn
EKP0aKd83Lc1uSh206HPZpoutOLctMQXUheGIdrc0BFqjWJJM/E5HlGDOVRIXy955rn0GqCj/7XG
coyiHhKLwE8TJ620jZQ98BmYpcL3ktsI6YcPUi3XKBV4Nj/ehbFv5qUAjp9x28elpYuIf6K3vuoM
vtpo/ivpE+rqj2538KFa4RqcAqEWJLmDXVRsBX4ztQGP1Ra8E5sgtbQWB/eIFmGwg9CUQ+dIuge1
aQOS0+RIvICKg3l/Zmeu4Kuxss9vXnQDkF8QpxL9Y1evNJUzAIlHJ9UOLT/dpgYX6H2Lc/sSiivo
80TqEn6EKel1iB6lCFVTJyGhEab8g8blm/sm5o6Yhnt1UljHQrJVLd1tmgE0lcSJMsgCtrGoG0QC
EQCfIKOUex5ZuPR+1cZv9qeOwuukXwrxS8YDE96PkqZ2ifNwVqgJrAugmK9Thv/85+EzND8zJGfP
+KtHUZI2pry+jJ+VGhvt6f7QZ1o+EaCjZwqPMRSeQcx77Z99v/OlTsSnyL0lNTQhZqLuIn+tNht+
3LR9ZHROXVW03fIAu40+3i02YnewJNZL9B1zIPCrxwLzLboWSJ6gFZrDFWu1DtZcYal4nAzHLKSB
vkK+Iw3/upJR4n31AzKRYalSPZdduvoC5h4phL6PpQHPFT/+kxG7qppNG4AvTrGJQtvuMPV+jD95
HNEk2/RLaIy5V+TUPoD+SKQPsSGZCEVr4pbL2lpzxAD9zNB7bZLxWQbupo6fQ+lRdB+gAOSFX3Xy
V5Fewm4zfI1eRSFKW4XvfDAYfU4FqaKlqKAkWVFB/K7fk+eeLASjc8861L5Q8kYxiFcBtrzeNY3M
ea1XVJrj6me8Y73ENVu0Gmpp+aAMiaHJEdXDXVJDhkTSUyN318Noon/GFJbmbMY96GAxIKgRI3xC
4eD6S1pPSIK8E/DwHkFFkm7jJVGVudseFvCbQYag4+JndqXvSVmuVorm1NqqIaa+5uqDoDxMfDLF
IVdlWlS7YKlhY1ppxkNcGWU2YtdAgdpNZc3R0xdF/5wKXbVkL5z9aW5ujCAZBiIrfSLOmeb2IiDG
LmlzLeOQCeBDgJQTHSiyRC6ATshOKdyT0fp9aPcAHaPm24dr0DSWD3zYaAeVcCoVcv1fZFfhjADf
xYIScGAwb49KLNJEqLGaNfcgFCv3iVN2UBWRkuP9oc8ECMgDAtJIkA0AnREzvVVdhHIRYXojJIV4
xP1itGuqNUoWHqI5fyn7MLeal+aYYQ1CNrhVKSHjFTzU4kcePCjBEoBoaUjMkdS5KG/GAUMKG2T/
M6rltlBKVCwssg//RbyNBnMskyBNPEusQowm1nHUyJnuJGgnjoQXqUGBkDtDZHfhCT7XT3hliXGJ
MuitsihNwY4j5m8xeoCGGGTg8qpybdJVu0ynpPiomkmQpl4CLc+6OQF9A3DHyOQAI3d9QIRMqvQm
KHRHXMnjKoqeYnJM3caQxMdI0FHZ2yjNsda3ufTCgdE3PElotG7W9/fq5F/YUzo5OOStJ30viVlY
eZCloILutwOFGKMGoceooExeekalLWRzpl3PWlLxPEYcIElg9GUspZkY1OHI6WhISk3F2w9JQ+tw
IwQHrXu9P6i5E/GPqRs2wjSsw15vPddJ+G3lgqAALeMABtw3MhPcwK+JyDqiXxO94SyoDkLF4cCF
2DxB/FwoZhobSnMWKjwIggev28RAIgSbLvlDOEB2CksHL2KzAv6t5tZkATJyu4pIcQiIsvC3SXOH
8bUxgHZ1q+LExDn/Dh3bM0AuDeVIZ8dStfTonskroMMb/b9IdoLqGj1m1xuXLwQgLjsBKykoBtil
8nJKuioI0bUgN4bY5qn8v0pSIQpAORWZFXSSTmaZoLaLkOvv69B1akSGHrSDRN/oFuBB8wO7MMJc
91UtDnyg+a5TxX/D8KjbaUpBmKluyvGLk3gzHZfexbd+VcezA4p+EmAJKD0yU4lG+oF3UUJxfAkQ
XPc9C1Sn9ORV63/H6R64lIU9ywQ06HGEbtv0bAXRLkB8MnMIxX4EXbEveCddzlcEYMFItAWkx1bI
ltdbb9OZHXFp3Fvjkv7H73G4OP8wDQ3BiWpmagSZduv1rikaT9aiPg1O5vnPYKWbh9GsN0h0ZhSd
ghx9rAzQO4DGyTe1DUBHlBrP5t/DwUBXf2fu94iEzBYYrHfDWB/wZz3Q5+fUeM5RwEIMaGy3W+N5
bd6fL+Zc/X4z0gqYMgTuqGgwu66p86SQdNd9EYr3tEPusN5E/pPfr+6bmYbOTs2lGWbf+W6mgMef
c18aXrG82KlKKCVIipGMOylZ6jP/pYm4Z41xFl5WIA8UwZrXmZBUBqa0Nau/+f7h4cF+yYzNz9eg
037bG3Q//o2elrL6bJH/ZlKZS1do67LjJ/umuqrRH2p/VihaenQjPz298XZOVRuaCVhUYD8X9j9z
MdyYntb7IibVxEgj0WSauLac/xWixwh0mvcX8/aITS/ef/YMs889L/eQc4UNPz4VDRoK6gVYPRs4
/GcUoGVBnl6H01eYBYSupNuNUsa9JGv36WcFZuGt01H9+0GiOwXgiPvjYVzU/1uDw4c5lJxZ3Alf
qF4rlQ33AiY52tebQg7pwDmk+KzVt05Z8MGzKwTfBACwgOCPVcd2xVIeuaGFNQXvcDSJk1dpWCIO
ZF9dv2MC4wCcIBYKgBom7TOMHRqnU457ydCcmqy0vUa3fz0TXRcLkzfnQDAvE3qbiFMfxPWGAwWH
Rqre5V56L7H7HDyhEq2qh6JeomyfcyGXhhhPJVVypgQ5DOlpR7NBoq3MU5Ay04D/iuNFfNSSOcZj
IXUhV26pcy87hUbHzhIPHE5w1dEvwbBSy9iqu8P9bTh3rHA1I0SdqsrQsr6eyVIqpHiUMUDQVFgq
51OFX2Iom9l7eEeB8wjiFugj/IXLXniHHORqjRgk3ilWoQUUlPuCkxvqB0vowJkTBbwtUu6/eGfU
i66HopGwC9ux8k5plW3BWvXoKtFZT4NPqRhokbS2IPILx4pt0552/JVNZsF6ufd9Scu804MNWHNo
evQX3fzzs6GrDcVla2zXrhMb3uPzAqiK7be6Mc24K6FU1KoGhvB0PvPGq2q9AnK9ytbITdr2Rrfw
CZ8vk/9f1bT0KJBV6GhuTKNeHTparXe5af5dePTM7N6ryWBuIMJJeqjUhXcKAn2tjq7VKvweOnNm
UtZGVS3BzmfNwcmIqOaguMy2AIRCrrli4nmnCPhB0QoaBUDjdVTv8mypJX3uckW3CIh0oe0xdbcx
QxNb0Oj2suadmm2hGZWHCQUMRqP9Jnysn/DwAvk/sj0xLljoYxYuld2XjMofHfCE2TuI2u6fWvaF
/bv4l9/D3Lh1OQpFAYHxk9lYwvkhlKE/Kj30f8OKeoa7cDNO0SsT2VwNflqIiwPce6UStZXunapx
VRzbPS/sPpTBkpWHIV94zbLp5P8MDIk78HOguIqOyWtbXF/zSRHF/mmHJkIIDAnW8P29e41XjfHd
rRdbnOeiNjTm/mNvcioXYwtdX2l5yCGeOsge1zuBnKKd39pg4Qt5GrhrBfBU0Ko0sRn7EmjZdm3w
KPDnREfzxq6zeB4plC1JLaJwZp8CSUEW4p7fluSb2b/4QuZtMfjx6PJt6J+gaQEGUNue2iqmukP7
7W0NR/gjhmZNa+vn5fHRPu45SDgazwfz/LBbP8ufwWMA8Pfatb6J2UEfal283d+K80fjn+9TmEs/
lUg+yn7kn0RlByBQ/VaFpl7RQDVCsg2VTbYd/JCK5UY048OgPhQvlUD7j/rIpcZADrm/BHSeuwcu
lpTlj5B1NQi6CkuqaA+1+y5w6KwAO5ubm12tn5TMzsBTI9XU5UuzjLZVbkom0X9K7UFrPRq7Szw1
v2mCmxWUAF8CvBi8EmwVlR/Uvkj5xD9NeBTZqlbjmwiKCf7cmYnpukZs8AsndnYKLiwy19KQinpS
++B0J+VaLYyhsmMzHf6MgeF7C/uTzdf858ROaNeprYYg2X59ghqhJi1UQfxTIdtSYoiJKT+Xjh8Y
iW51DhJ/JvEfK94koCC1MjB5jsai2Mx0td/MMAphgBgBkYGQkPmGQS0TPWuw5DXyCqXF8dI29D46
zyhAYV+n4SbRohUqZjTmK3Amre+fgbnAV5iYrCU0gYKjj81ZKa3apnEK+8MKRZy/AN1CoAgQIwO0
GQv3/qyHxGSjux85VuWmubsdfQ/bafBPCZfYXvUajVbi+mbLH8RgF6roffWMAHyz4nsBZTTO5IkB
oZCFAc/FdJcfwcRaY67zfp+M/qkhz41m6NpaAJICfDSZORwi/zAMEFnPoGcQ2cNGxBNfLcWFO5CF
Bv1uPGCsQQ4G9w0EP/MNUT4K8VjjG/KA2klsomH0XTJSJ3VOp1NiR2ZmQ4QHLm8hZJ5fAbSQocCE
BkcAza53W4+6Uu3xKjyekVjEDk1QcK1XrWV9KMZ39rmkMz57RyHI+a89JkYPKiIXvQJ7zdbs9+VL
+gR55j1ZZw8qxMbLteSMW24FPmOaG/HWpxBQQyvr0pLPnTGg6pCUxXsVFAbMOS+9Ei3NcRWcuPY5
5s3gQEpLQIOftyUoKUR775vbSvnCIs9GuZdWmdsv8JWwL1tY9SXDRqXd/2pWlVFRe7oH0Rq+SzeD
QehgqYH1pFKVQtVKMZyTo61L4K9Pz8PbbokAas67ahBtgPwTNh5A2Nfrr+dRrSfE9U9BvvLrl7LZ
peI7kXY+BHKWZn3y1Kxnm5wKcnsEQr83+LfUy8dY4pHeA7sZ9bbDQ0C12jAclPcUQ/g3dycciwZ5
BXSFgEOEGVqZFEBucMEpazxLkb88QiXRytHXpet2oz5BNDmoLC77Wxc/xT4JTR8qImgLT8pVrC89
vidjzNgxuwBbyAB44KXPzHNV80D+eWJ40mvAKNYCf+jcVagsXGAzzwggJ5WJ1A1gLaA1r4fcSyH4
rQYpPLX1lpOMWjIja/CftPH7vs+cfg8zGsgpEHkS4wCzAtuPK8qNptUKF5+iJgffDMonIO9vNsFD
Ka0DEXA0UMndtzgzf6A0npRiUWOH6g3rN4RW9aNej+GnHuvtYA/H+7+fRV5MHvjKAOOByyoc3LSB
gcwZd6kp/uS7GIJrg08nQbnuk7PvG5wfEDLdiKQgWM8evCJFCFDLsCeDu6N6A/gnHbdh+nHfym91
gF2pqZsRvh2SJjdCjkKSlGJVhMkJpBRZiW5LQsOXet/ugand40090mNLc+sJIrubNLXqVwFp8ueF
mGImMQN1hH8+gnlx+rmcem2DjwD/miWPPc28z/vjnJlNGare2BiIFIHTYp5andgQtNMV0QkAGqqN
myCIaVccFrnHbvc9Lg20u026S2AsmT7j4oVVpm6cDxkGUrbJK+FrDSXucqmONReBXVlhBtPqguzL
dQBNYv2xbbfSHpA3I0zOsfAwZGcJdO5QyaqWYrHppmd2ypVV5k5sSrn0x9xPENlH5FkZ/1bjAfKD
qfciVHgPbYD2ub9mM04EEa4MJ4I+EBCTMqFHmQV6C87k5NSBJQUt12F0HPr3srZ7saG5f1h6j9/s
ETjESXkZYD4UCG9wNC0R4yJTs/QUDKEh9HFuRN4KjHqBEUfigru6ccSMLWYJZa1MeiGM0pNQETNs
IezE20nVrgK3Nxv+6/5E3hwvGEMQPaUldYjcsGXzLCVDRaBgcGrhrLz2sy2r7/sWbp99kwlkp0Uw
jKB2ITObIxfisBWENj29JhQQ0sFoz2fBNULF9p7E3Y5b2ow3MbmCplK0yWj4A0gwe9CkvAiDKAZH
20SQg2wG2h2QDQK1ISWrEWoQCIbvj/D26c9YZFYMbJFqH3FSftrl/e7To8GqRUfFT2i3FGoExqGh
32sj+loW6J5ZvSnpN0ExJyALG/pngYuWXS8oTnjdmH/0nctR16aeaH5AYDQ0v5fqDTfHDgNFux1o
WnCRoueBuei8IFM1t++Kk7zKqC5avq34xhjR/KdfyCjfxJaMpSkevPCWYaIjzUhgqQm+Y9V8bnj6
PPyPgGBQkF0PZ5reCyNKyIlpOxlB/wIEJeW1qtOT5poLD6WlWWOvMJWLxNIVilNheQk6xJCIhmi5
T4V35SUI7Pub8TYYmQYFQk8UGUB6d1PzR5yoRDgeBba/+kf7Yyd/9MppNh/t6hnaGa31L8wBfQzy
Jzz60TvODE6t/arO5bI81THeH7vgo8jsSjbfQO/27AGXR/+PtO9actzalvwiRMCb171h6FkkC+Ve
EGXhvcfXT6LOmRGJwhBxdaMlRYdK6oXtl8vMJWja30QLBghLuE94OJK4WG5XjXXErPTdtrBRXevJ
gGgPLSEy8Y4KslYEveqPEk1SAGRpE10q5hx9D0se5d+88+QbJjun8eMBIWBV2Hu8P+6+rnVwUVce
pRkaBTpJvz/Jczfa9Ygnc5wpwB/kWlfYhemuou0SCGDuhr6Z0YlrwkIuWEjlsrBzf41zTfS9CRIE
tnztQn0lPCiPSyLkf92UyfxNbkwJ/CF86taFnWh7SbaaF4bH7gniU+5stPITjthSKnBx20yeIUiO
SGElYNsA5cAx+gDu8PJZNLLYDD4znojNMUXLWIwuwMRWQBTIhFR4hcCKtHhk/nhLGLwyctaP2vPw
rMf74uraqdqwUwImLm3OPcedHqkJUbjN4NCqXQXo0zaWauy/IIAb/wyvIGQv0fCMDi4QaU82EHz4
vvZDp7S74iWMCG9Hz+DLB0y75UlwUImyT0YqpmGjmgISRfd374w/g/413EdA54AbTp6cFZZthCDS
tNLO6hf0dza63Fxi4AKWNAFnngwg0RDAouzOobw/WWDWq2OVS+PKRm/VIKwU2y322EiQoO4WqjNT
/pXx4ZARTaIuA0wjhAcm7yByInnNIHduswbw0uYH+owU09349uM+KIB4eN9AiZFClY4liQXlQEqN
86X43r7kRA/JEih6zv/A5yAXxaLdCzf+5PwOea9JTitXdlRTLzYZaNYYyc7fKt0PVnYVkdoatG1Y
raVhxXukRb6d0cWD+hO9FEts+H/Tkb9z88/HTI62O/hB0xZqhUe1+Qq3H60BiRYwBZga3DBUPAAL
YTa8Zyik3br6dil1M+6m6VYHmG4kAwYjP3KFt4cLVLlyw2R9bRcy0wGOJAwUmLrFUY6PzNSMDAwB
YOGAzcPBuzVTtLHg1MxoZoDw5orhn6Ji7VtaQ8rYCDiqrLwGjedoyQZ5lAXMIJANEqAgzbvaPnvq
NhC3dU1T7/X+WfttIrj9Lojj4NVHGwMIi4H0u/0uxNFBrcR8BzQmkc8OY/RWUxjCZ6grq4ghg2t5
InD6tM13A6+3qcEJxygAmH+lJHoL/oR8XVs9p2fll6NzjCFqJEgNZ/gK+YHe/1b+7xzefutkDuMo
TEPOZTu7JHvsSiQY3lA1GDsHBrBa+sZjss0OEr1EFJ7E14Lxv07ZrfHJNkWW0VfTfOgQsr5FdN8D
Cf0EBQ/9Y0yePu418vbsk9d3yeKoTQ/P7wv2p7pPo86PAGlRZPVQSEf4NUlKMZrYJWoudXDToPoD
xPsqRvthWOgQnzJdfWSOc/Brwew4pdPtcW11cjpiQatUUdI6u+oOvQT/LCr1VFvF3FKkIPw9h7fj
m3hpvDSIIlq/O9uMiXnU34DvMWtj0AcCOgndoDtkqT9GYpHYgq4R4fWCUHZLcVuTpTz1b9nr3qjH
b716cCHx1ck553R2/JTshGeIgejDCpSpHn51IOStRnaTL6B79RPKBrqRL7yA087fP4s9OZXDKJXK
1fgAN//iqm0CInlxBxAC4ZPXMMjGxs/IXXr1Z88XB9oI4FVRkUMa73bYjO+mkIBnMGzCfZre5eFt
zXxW68AE3uH9XVDQDescnYMAhSnWJQz60xbO2N8XGXsA3CxIR+LZx410+wGS62v8oLq9DfOAPuzB
0fYIHQNy/ha/rPM6uljJQCUKXpPD1+qHFnSpKC/89T3wBSNaBlErLmt1svIMEwUi1GJ6+2n7ctz7
2w8wpR2OKFWBLS7bWpZ1MC492Wzey/XB3kQGdA4Selo93Z+IcXn/7L+rr5gsPxdVfOrwEeYBNILF
s1KGJAXn/n0jcwcOyznq0480IVNcJloPMqUos972B8MpFQOiSMZ9C3PLeW1hcqSL0kllr8h7u4xb
2kmjNjkObmi5HPQ2AB6R+yXag186nenMXZucrB/XA2nBK2lvZ/rTfo9iQUq2/enlZf/m0eNjvn/E
Ew+VLnruyHogawdSMI/Cdh1Ti0Atxk45YnsbvHZEe1hdArIxksMmIPZPQpdk3OZu1lHyBC4uK/3N
EIrMWKCNcdhaoLJa6RQMbxmknOMlXMisHfS6I3ZAuyyAr7dnKnCGIYjHM5UhFz6mPlU4V6yMBorq
5/5yz+3asbAu4+iOrYSTMCVzhKzptbC38R+1RJIKWst8SxpkQP9XhrTJPVVCGEmKxkOqxa8Ov61Y
W+Be7puYnbV/xjIlGUSOp8xqMehtBbQRnruLERhw4bMLArb7hhYmbdpg3NSSq+E17e1ahGZknOAc
JulA8tBb3zc0d9yvVkebHEapSnumV2DIaRFTaajzp9W/WBdQbcDFxdWJbubJutRg/0jZqOjtBqxa
XITmUfcgBQvp2t9m6OkRv7YyeSRapWuBnIQVpIp28RicvOyPrHE0H7JVQ87d9nxu6GtjvL6LPHln
iQ58xv2p/K2X3fuEiVeE3onGEQtswEx/2aZEGQnO9qZ5POOpsobDg3ACQf+7keqXkZw/ovp9+3NL
+QucEUQeePrpke5BsvKf/Q+CPl1NRx7ZBR6OuV15bWG82a8coDILZDfoMMAyRM+Cp8vuU8Ytdej9
f1YSaJb/jmN6YUgxr5QRrPjBKiZP+3TsTjiuzxIy4va5fQArawvfozFa/QBvb5xLYDD+xQG8Guqv
K3Y1VKUNRpQ6PqIa70ftW7Ij17y/XnOziSIeYj8eCCq867ezyTVdXituj3NR+VaZSKaTq2tQKi5s
i5lIGsVC9PSII98PSPcm8xmFgSjUfDOg36UC1x70r9YfTaavwz0xdrzu0mKjvGd0pRr3xzeT3bwx
PK2ueZqQyFIFw5Ac8Cz53Q+35RsoxBvieFYurrSHJdmbOdcCTiILHPevIPlkg7JcEVQCtDrsGE1M
fQKimIBA4xZx8lsYLGRvxmmbnnbYgeI5j1VEkHy7fEmfJ3nZ8oOt9gmpo0vNZXomEBaoxpMmZJs4
X8LszAZ71yYnKxlUSZrGpTAg2Nv2tEasyVN39Sboj6ZrE2hbQ4J9sWdoNuoY5RFkZCiAaZjmAkZV
2UBt1MEeQhPSfHkHBUfQQMXCs8+Qlt3VtQHC5fXC5hkfnj/Te2V1fIqvDqBba12i5c5gNyC5kEnS
GGgiVkTa1D8c1WKI2nMpFeMXh1/dtzy7rleGJ55RETU5y2cwzGsP/oYDJ3X4yqavnmAVm3iJtngu
sLie28kmShUHvATJaMw9tSDPl76z1Iq601JvyZRu5Td0HDv7wBs3ilBMqx2h2oRuLEiDvd+XdGsi
i7RqHnObMSygGKlvsrrN0c/eNN5PIz92vcqsnwD6ZKeF22h2wABxg05OxEH9jbSulpXLHcFvNW2w
kakXVLNaCSBApIuVldlFvDIznVdIMkCRBmaSbN8c+xzqVATM6hpVtaeKX2qrmw2RR801dAbBoYYu
0e1mLWvOR2eZx9ocgQSecXaNx+PHmwTQ6PFjvT6vSVWaLrPYl/z3xQdpHDLyyAAhD4T2yVuzeV0n
dV0xjc0OvM1IGZWEpVvul2/l9hyONgArFVAPlJCivLWRFq6XF3XQ2vBo8BLLVPvgtniJSXJcfyer
T9AdD+if25QVtP1sh3ir982qJSdFd5/vH8yZ/Mvtp0xmGR0GmRK5YWs/CUQ4SvgczkQAhxai2EKn
9JpdW8+vwMgdyuPllC/1qf7tY8JRvJ6J8T2/2roqo8QJSCVbW7Vf+h+eivQIGZPROPw7eff5LB5l
8no4VBQkgW8/qNbfH//8av+zEpMbcQjFUg4rrETWP8fVMVcWauUzu/h2gJObr2rbSHFFDHCk7G3M
F1OkAxJb35VLHoxkZOPd0NXqSzW0hSt3pth8a3lyXNWabZUijVo4ltAtj1lEpLoG5mwtBF1eSZRy
pUWWxx0L6SFKtnG2iDb++9rcfsDkZR0qlR3aEHMrkJfwADkk09MfhdV6TUTdMlhzk20uuBGXvMwZ
3+zG7tQHVLyhC7nR7nakQTYTPTIfv8/BMyQsNtQzVszDCmDZ+/toJrl/a3QSKsWMEsR8CqMQaK4J
FHvAuNVcHsPTY7pZry3JeI6QvE4Ia77COSQ1N5bgW6IveaYzj9Lth0wCpl5qweX2e7fkxnicW+Pt
rQIvNBjqEDnJ9DHQz1ayJfFu95pKxgF3OLmMsJvI+lrYgkun+3eLXp1uXqvzNE2w+ZnV08sAfTX4
VjI1145ebT39DKW1naEA5c8Tzt6cNP20cLoXP2A8/lcfAFmmPo49rAq/r6BRMXp3eD8wCT5Zd8TK
Vg+MQp8NY4MZiPYnz1qIoP++zLeLMbne+l6VwGQD+x7ghU4LNQebk0nlJDTIF+JIfgxt7jwqv9jx
q7EGqlZ32niV5kaMkt5eNI5rg18/GNzmQHk8JBDevb/pF6d3crkJZZbVdQaT6EqQQF679i4uaUa/
AHHlGe1Ou12s4+LeANH//HUSvuTzEq5/Jo18O8WTa04JHcb3+fG0g9RgOzYqoFuB3RQ7LDRUKki3
DaG59vD8DPZxUEhAV4MYESA/xDlmBC3qWPrVamHZ+XFf3VuLydUXJnHuFs34UfvWOCLXiLcd6c+z
9Ulw8fkPuPNd7HZhvbAgf8Pfm8n43SNXe2DQPCYOR7shEfcx0avd3lSAtXX087k77whzwlZAlx3i
0oWjtrDTfy/lK8uOxClOyMKykOdr5KvMPku3fuXSIBzMtOGX4uC/zujtSCfXXFGUqRdnsFfoL/n7
XtjBHyRWC7lG9wFDvLimvrCoMzHbrcmp1wZtXiaMYDLTnb1jSaa/cVbi0dn2S/fm0jJOrq0o/r8v
2IjV2u+b3ZBCkyrRf+WPd9YDUm6JTA6CccE22goLaZqlpZxcWpXWlak2nig5tqrScoC4jwsaDWtQ
gS3dIOPpvHNQpqi4UHWyrNBgq7f0wCfQUNznxET5CTrP6/ODQj/Vy2uKe0y3f06gN9gubFth9gNG
AVLwDoJLfqqFofZRGUCAs7XF/falRmozp+Y53J9BVttSy0NG57T2zGornFG1SHF0fJMmp/GxWqnD
2LO32Mg50zKCfXb1SZPVz11fLaoAn9SfRNB+0T2ucrJWBvSPOuYnOSBFd6GIBRamYnbZr8xOlh3Q
wDiPBSyF1Ke6TDP1FQyI1MktiHTcv6Z+u6j+rPqVqYnXnYLyKWo0vBsQLD81n2NwzML55+lHAhTo
KPHtEm77WGAXrHGqDwdeR/E3RQUQKF2zeNo9C2jjZUEW1JDvoiJnfv1cm6/BQdoYIAnST4AJ8Htm
J/dLkzTO/b0vn7x4fOTxnSjGrV07/KEOWZvhhKX6/HxMhq04NrSzY40UH3F1l4KgMfc1dXSbkJFS
Ro8F2SgHp18xQKCcEKA6DGBYVgmKZ1v3Y5Uvwsf+7gUwNbNQYgTLMXBW0/rSkPNlo1QoWNZspAdV
ta4dpqCsEx94VSEJq0T6/S3BjWO6ndgbi9NCU540XBt4SW/rDE/CbwiGBoa4PTE6NuOCqb+3662p
yfT24KkKBw+DAzmyJR23kHDd7sGFBZ/F0/OFUzVu5T/jQuUXN8yY/5p22HFNWhVNh3E5HvVzAryr
vnCaZronMR5cXmMbKsg9pzzRfgm0Xz+gEAt6jRF0//bmrkBLMJDn/qjW5EBPQ2Len8OZOwqd8yAR
G1Vewck2rT9pqNl1QeUOmMPaaNEw9nE8DytZh45tBMgRoXZgtOQnoEv+3swrjG56EcCIkQwOmP7J
CXRCRBRMLfV2UG/61sgUKGRWh7JCS1fsEqX6BGEDSbKlpOLfd+LW7PjzqzPZ8LzH+znMInNq4E9n
4GTuApcyCy7cXy4FaL1cj2/iOgY5GM09oNXtJyTZEv2IfEi4fRT0BJg/bVvSj9I6+kZJOWQbwc+7
P653Br/d+LoN6mTLTk151VibTWMdcvNSUfy1Sc0LS1jo7IGib8FXmNveoDhCumxEGYN85HZaZPA6
RpnkDTbXX5Jtntuab4att7DFZwINTMqVmfFavpp9TixzrWix3fhNfcoho2x9RsQyjMNYqPq5RAZd
VebqsnoP9ci6v9XnrkLkA3EVi1DhxX6/Nc3nWZzFQjLYLmT3KlCoC+hHC7aMAJVDUV0wNhM4qCCn
guIGkstgBpQmbq3mBKhCpqgLJDtmm4EkD1uAQfBwVugHanTPKlbRIcwe2ZPCWuqF+utT3xqfLCYP
LtmijpDgdaFY+JRBDNNXkOXlf0pcW0UOB6RaJJ6Yu/evBzxZ2UbzQNcZY8DcrgOEN1spCvUZWm8L
gfSohj7nyun+gs7dIAAgyeDvRJcGQpGJo8O1SdQIEdfYyjOu/JKUqZmLuqjtG9uJ13jT79ubmdUb
cxNnpy5iJnc7trHFTaADEwcxYA4yM+WD61lOtcCqMbNbb4yNP786KGI0SFVUYmzgPWXMHjryxUt+
rJaUyGbnEJ7B2MmLki2Aybd2tKaSAzWtWrtjo+hBlsK92qY58ZxeMuocEgVtEHNETHJU0DzNksSe
WXrGx50xeVlxUEQIY0HIFh21k2ccHaqyiMJsY/udzgaWlI1MlswmfubP6Uf+IbQk/ri/kvKM53Bj
cjLq2Je5rHFgUmStrHitoUT7Ifo087dsQrhcB/myz6297pXFMne6lO3z5JRJNEysTttHzlPcHyu0
U0oFKb9DrRqJxdWOdv0+dc4i/m8tMmR4JVg86dS/gbpA7kxv0OOUljn1VStKrDoj7WXYCKhKVl9B
TqpNwtK8evaiT1n6TNqzDB7hdi2VJY2dnZwZnbL2NxDDAcdJRVlA4fsFCtq/rIQSqAYgwoLXGILC
6lRor+lq1EgKlEzEbDtcSo4yZi0ew36EVKXepu7Wqm8IakbShwQQ7OduqRdt5nG++YDJJYLEQx8J
iY+0R6uLPYl/eu8HJeq4sWp5oUI9gy/AYMG1O4JD4HT97pGrEyawWcVXeIxsPoeGdLaDzvBO0M3g
2JiFmVjReqt6kK8ctrHtmEOEtKJAHTNGCHtR3jpaRAQ8GMzCuzHnA9581eSSibKOabgeXwV6yxfJ
IXu0zY7ts4zxwoCor/S3tWfRzF64S2euG3DqsBAaAmIGWtITZyWWM5nJ+6izk0HGFmVpUsM5Qko5
B2wveLl//GYO/EgNjpZZFbBz6XcOrmYeBVg1Stu8s5WK8Z8aRKdElDtnYTfPlA+gyAWhe3DWovkb
zR23V5ukpR7vqGjTVyJoTHOiGTm61nk6qJqyhhSKPaC8iiq9Aw831n0BTREtBQ8zFfuLXGzKEtx1
BQMpWPTvL7jdcycNuDoNTTw4a0C4TC6gQHW5PhyUzg6AgurMIt6JUkZOufcNAQdIqNL0oUUsXeoO
Q/PccpcIoGdCU0h6XH3AxEVo4sDHhYzW8fgJDF/mW2u86O5HSE4/K1RWVuB1zV3KvzYsifst/s1S
Dm7mpIMFYGyYRi8WmJwm7xufN9BILBBOFehdR7bIafV9uDKPA2GP8rHd+Q/lOtis7m+8mSY0jPrK
6mRLVO0APicejUvbyozQMUHCQw5l66P5eI6t74rsWnP3qVC0tbbrTbe36cIHzEXHNx8wOWeYi1G/
boyO8Q5wJih9Gr175120aF0W3tW5GUbhWwRpAOD0IMW83f59yjKy27PwQIE/k1Co6J6S4XGIV722
VtSlwzbzokJHSQW7gyoCHzUNj2W4CknZcYPtxVR4qd9DtFEg+fZAZP3z+fnQGIDHgjrx+1KEGOnS
tC5ZH39+daMoHpOrrQLrVb4HByfuTQHAH6I5A+kFmsOVAbFLuFI8yj96+cEz7u+rmRItmJnQQy2P
h0r40+IQhaEcZlWP1irFzPceR1T3B40AWw+RbATFdOk4NCsX4p3sguWZRb4xPB140Srga+oQTwUr
ntu4MuHVnSI2ULSiXroQvc3EiEDSKIiGwIYrIW6/nWUtz2pGLRBWVMKu+RC1n6J71JakY2ba0REZ
jWkBVZFAGTKN03JEiFyl4XUQyFNPW0N6Cb7kn27HmQqqjpKZk7fBbHSWDjvVat85c/9oobVhoNk7
XulRkH73CpjDxrB2O+O9X3OG6Onl+nmgu9fN5ue0cJPNrYCoKBycJsQhgEXeToqSNGwbpHxvR9kJ
dJVarmshkDZVR3k4zff32W832cRVFq+NTfyjAqBWVvFhbLs/yu+RDrp1myjnavVpWQZQ0SCQZMC5
zj+3ixf2TPRzY3qy0xpNqNGCyfU2b+Vwi3zyYW6/nvYlUGTRk2Zt3pm1tHCDzd2WNzYnG66FfrlT
SbAZk/wJ4lfBes8dsqdg4fqYC9ZFdGArMqhHkCKYbuxIrEpmaDCtKRJgiZ5SGTEHKKVZaDEDewr8
g1kZ6kus50dmrTx8SY+gvXhMF3bSDIIYkqVXnzF5ExsncHqvxWeAMJ4Dj++hwuTym+HFEI+M3XwA
a9kBvAfO1/WFA55QWtheM34ZWtDxCxp8HOgGJkssOmWKWcDJ69PvMjiU6vn+9v1tpp1u39/gAiIQ
I6vMeJaurukhGFBM7crORjvHW7MW9GEnPqkb9O7LaCeIdJQLrMII13mhK5Z9QWlE039GkQCQqzEP
DQCMFY3NHqmTpVM8P3SEPf/9ssm7jBA4Z+Ou6mxfYctt6ELNSVKjy/3xz92fV8P/7e2+Gn7VapXA
ZQWMOPwrAw3whypNf0qXb00gl5L9fWuzQxol6/Agj/jpyW5ye4AX6hyT7QXeJVeBtxeWHv0lE5P1
FKRSagKn7uynuqcxRCCwrMfM/O0L2sVrQBBlgb5uLqhT3x/b7ImFesn/G9x0vfiOGbhfyy/8Zm8K
wJql1tm34LzruW688tgjqx9tHaGyspRdG4/Bn138j+1pylxOBLXJ66azG1latewTq32w8mDcH+Hs
XrkyMvHe2IrpwFGEDemm35WjK90z55uBF+v/wgxgJ0hUYzJRrbw9kV0JEp9G6Do7y1yqVh+uYDbZ
pUT4fd/OXMADn+EfQ5OtEg8huFT4vrNVrjTiBIhtySkIdlBKEoC3PTQPhz4SagH/IwQKzcC+1zQo
UTmSaOZKt3Z58Unr4oUdPFr9s5RXXzXZRoKEhniNxVIOKGQ+8qUaml5UoFmyQg+K5+XhqW/Ej4JR
hYV2wnFe/xpG5QM4QmA3pfFkXV0FMeRBHIkBMrrMqlPL+0aen/rhSUr4LastZd1nWuNR4QHcALpC
CiCi02R0lzCI/HPkZp0SDTO+LhcESmYJcPQhdHG+xArwvk30XIHNBZQd3Q/UswcB7IcLOc3Z93wk
xxhraHhnpydHkhoN4jXoBM5/YvfF4UQ9Eoy02QfCuyKaQSeQNEO/s/aysPn+dlRh/CAyGwtrUE38
TYJezbbn8Q3rNC6Lhg+WpkgV75lDRuIH59lbyKPM5VNBZYncmQyZA/QhTFyWpO8aN+Hjwda5Zw7E
Jh9WjYJ3QsrneuEOnHHI8IpCjAeFQqiSTjkeoXk6FE6Cekawrmra6SW64LqeROel6Abk0X9366/4
NhiwkChGsv12t9ZhKVZhBsdfg2rJXusGRzbKCglhExTHnEqivIKWUz44YmdGvMJ85J3ovPRp1zAW
qyadTNwxOCShJ2kyTQVPApVsIzPpdyd4VfhYJ7LMAyehii5hXTTA01Tkw+SsyG6JxqMiRy7Cj9Is
2qkVlOMNORO11EhjZHC/wih0WFPIVUZFklVNfYhLSmyvF2LDJsfOiyUIog1ALRsjrDQxkxrdrIQX
KhAvaBCGEIgb9r2vd60byOt2aLWTEDeRcEyVtIu2Yp/y7r7w/ILRZY9xBBJzfMZaQ4payhbkCnxw
jJNKKl6UVGnShybwC23dVeiYtIoyEjLD4WUffaJDG4mmBvVQbptmfV9s+Fh2xjoC78h7yNrmAKi0
jsCZSVS6j7gDve4S935U7j1J8hRaaOD5JIWUg3Q2LfwAkZ4mgvhck0W/eoCuFhr3q45JhUMfOVVD
xSHrAc/oY1XWfYcJwcbDR2xtSA4veCuuUDsf1E45G9qpGDXJpyTF6GYnXS/6/gd85B7kUqGTMt4B
NQIxO8lxq4krpQM5/0nJaw+4sr4QGMJXfJ4aUalEPaa+6PyBqm2cxm8JWKtkw0fSoPysVN4tPsWy
jl0wWA0lk6zqVNTajcswUvAEVhsvMDwgYaPHNAz4MCdFCTQdVA3iQD40jSL5NiQYXEDZUAcCkF4L
uww1n6LRkJh33VrxaVPKCXd207Ye9Ai/zyuSSzX+mWlJYocaF2ZGm0GWdFsWSI78RC7nR+2mbCLJ
OzB1LUuv+GMytEjEStu8VUJVVVTME+0xGqK+J11QS7yR13GU6k4OUmaDj1MNX6QFSneoCsbzjLoP
eNmC3rMf7Gpe81KEgqITSjskaRh/6xQOm+yZCEkxCxeIij8UKPOtMIgQlY+bJu2M3k8T12BTp8xj
WhapFFI1ByYYFFhl0hePLhdyQgD1FK1NLlmWKcMuUXKIjkR8FzFUZACRWglJyAuGrGCSOJIhYdHq
+JbKXVep2CRg7E4SzqiZQoi3ecommDyvrSR+E8Kr4QB/q0K1IwBMapDELts4X8dxy+UPYCGIFLT4
9nnfrxyfKdmLpHZomxk0uVDf3FZRgo8hLTLJcntGLlH8kP0GKtWR1lOe9xvP5GQ3FLBUQiceBhlM
STgbNYSrvV4GcUXG16wVlUWUgLUl57RPJokhisC6tSvpg5Px3xrSPJ6pSqXrHb0i85gDVyRcaESx
m1cGo/pdanI+z2YFaVgmGnQXgBT1p00SxgBly/Dcgd7HhfJR230vPDIzTzook1F4BV8a8CBT/idx
aEK8Qulg+5WPwrK2bQKbZdeKb6NOSTRp3yVvjfqYhx/oySG55/90XaZrzrcfg+tV+1n4nJk37z/s
V5DFRoJ5GtMW8ZCg2WQsd7smU5Fm0DkLKWUoGkq6mlv3rc14q6isIwGIuhFGPwVKJxrnMOBeZe1E
VmNTYNQnSfXNhK0DPWD72LxvbSbswJMHKSt4LWD1mIouCBBKbfIGQMY+kHI9qXzXQO/M630j3KwV
IEIhpICWBZAP3z56QlWrAesBwhgxAJkjJK+zA1dj+iok6KVHaQAYoyIIvCojckGroRV6qqq6vIhR
ncH8qiCfROoNIHEeL9UkxRTlfpx2FXBwSCPWxHEMdYM+0ugS7ZrV8MLkVvmkrmWd28YqlfclFFqs
rtMVlC5dSy03FfgLMuPJM5EwCE5LbsiMC412KFBBQZJQUTlpMk1u2qGJzG9Y28nlgrZNjtoFF4L9
BIeT8J2TkXAAsaTfQax7YYXmTPPoIALqBzI5KKXcrpA25GHSci2LCJfwp0E9dyXQ6/2HsilCS+NM
X6TdT2e1GUWhpzr4j96SuPScYzTKMCIlCv7yPwxVIp8XYYiUgR1JUasPTdwTPgfoO3OaJS6Cuf0I
ASLUy+BbShBhnYQMrIRHFw297G/yBElQNLm+lS8Z2WQLh/mv0BRMXFsaR33lLpc1OGYFNmaRdmtA
kgQiFTL+rjY63V3JlkZEiko1QbHUb8gGbYySBaaV+rHXly6xuRW+/pLx3rn6Ej9SErmS8CWoEI0f
sQeE0HoApq7Ud5sA2Mh/kYK7Gfp4yV8ZzCo8I4nwH4MjF7feNARZ1nF8jeFSSqGuuZB1+30YJrHg
jc3JCQqQABLcGguL5sWPD+1gbVydgop1MYU73hP3DE2iXb9V6rrDgw88lakP28wU1zTWm72+FATN
XJ2QCEYlH+cSLCpTPK0UxJnaoDPaTonr0zevMIrn4RyiC8IhI/6v1r+Ched3bqfIHNqARBTwUESb
LFwUOClflB1rmxJDuTMz0M2JX9LMWzIyWSkZYaSURzASrSGvudNwKigaRjR94WIbP3a6UNeDmSxU
pDBlx3O4UyFzkz5Hr+JafQq0k3dE3ynITraQe4HPFgVGpRqeQsSlUzC3UWQFrw2KPaBhVCcXQJtq
cA37lrMBtaocEkK4FYR2kam+HGwaLoFd5naLitQ7qGYRWkra5GKT81xVW0fsbSbl1mm55WJ2wWGY
q5uA5OEfE5MB5YocSwMj9PZwcUJw0L2/mUCnrostyKPPkAki2h4ygQk5oPR9QnjxdX9B57psb+xP
7rE0ZFRIBmKIqi0VQHXpb4/wES1V962w3YxwQlwuKwZ3i2NIX0tAyqUJnpwNluvaOFLRiZpF3UGV
01XNIA90f4jjCKZb9nqGJ0ejzHAs20JBecg1wVZswPNVs9wsnfzxXxhCAVKG6weI/FT+WCo8SRyE
AH2G3tg8oVU/6WCK4vq+FWH0HabjQcoIdRD0B3HgZ8LPrx4CP/K7OFUddO8KBO8A99LTl+JFf0EX
L/iwYsoBF9e++tQwMgL54n57scsHunRlj/vy3ldMVi4PlTgoAgaUStnJk/aMvG2XiKHmFu56oJOF
i3wOaBEw1KMVLiWh0qPnrCdFDeZKgd6f07n0HyIkMKhzyP6BqWtyrVW+wKdQjx4zVtJLvOK2QHwE
H/EaRLURWoE/7pubdZuvzP3JNuat6kEpGBQyCNKBDEDrT6cDRbxOKeoEOzDkGParc3z+hMMGPaXL
qSaLYmGzUdg/Q1Ymafw29t1YHDzU5/t9roAWKzuxqu6i4tUCOSyV735tMKG/MNOTA69AQRE+OQ9I
Pij5xijpdvPWWu7LZap6OynMSqtO+WelFXP9/vxOHsM/RiZ7M4hTLhB6yduFRfiNZsf0ExSw1OUC
yvqZLmf1/3Cn/tfg2MolgHwdUe1kVGUo+B2PUWnsQ9i/akpGFZlW/OX+uKbb9NcOD/FgdECik0Vj
J9tUlVxZDbTW36WN7ikWV0FdMNg0bE36y5CTnqfMAw8U9n2zc9MJlTMeonbgUUCt5HZ0rugniYT0
2S5kV15n+ilVPgqH4lCO/bj3bc3tj2tbk/3R1p4T+jFscSl4+2L8vaTlsWRhsjlcp0Otp4cFDYVq
5v+Q9l3NcetKt3/osoo5vDJNVLYkyy8sB5kBzGD+9d+i9j3HHAg1qO3j0purptlAo9HosBbwmvP+
35U3/9kltNqs3SgIM9mTBd4CVc3pkp5TTJkJhzcu/e6nH2dMLQf+nj2vJiA3rTeZ39aOvJIKBr3Z
WsEnKWsYtrlj8JhOSnNYVWjd5TUNhv1PO0TjsKhaytwin+Ssm7WRI6utIckSNiOJn3XkpRu5cZH3
CP7GqP5sCGPAeeTk5azP6Xkhhpv2D4X+P+44Y7WRblZ2VmG5IjX2yuSBKqIghm+1f1RgrFZruw46
QIUe4xIzsGo7UcKAuW3//1agKRWNfjrGbBjfIilKQlSk3s9rlqBR56DMgBhCvzUikiKuOzEMTPOY
IHZS2MLuYAxUx72OI27rByNLXxztjmqPGM3x+l65GYho1pkFNPtHtY1EJpBYVL0x6hgSk3vp1B30
3K2f8tPsG4iePBQTBlE7GtesNwKZtRzl2QIFZQUVAUNPiqBpb0ZTJITtIv5Qa40CkWECzC8axS8P
D2lL2jZUTs/qg2limFXOXf05DsxdH5BT8c14QF+xO37JvoOAFlOuDZB/RWVTnqLI4aJeirkltAwz
55c2UjGp1EzP+RyCuuBn4ZvNyYmOS/1g5Pp51l6AbUzupJ9xUruW5l8/16vRb2LQfxZgI51ZAJrk
8ThrFnwh/a4Ntpd2sic3GBN5LwAddV0W7wBqwFYHQKONRzw70YMiRWKUkb4ecdDEVAR92Sskv0Aj
vhQ8bteZR9y2TDnTQJVNMWotPaN0tnec7DijvHNdEd45R2JyHTTTwD+hr5+wcbllR3vDQg78nMqy
q1dh/NWcX6ZJkGhZLZzdGhBDgpAA8TSYmJgLZLS1VO3iCFJsHxwtLeKGTu+9znDzUQct0oDEZy6I
Lbm31lYooxrRcMx1E0KLeW34GSPZbXfGq6m8o904NPvkEA0v11eTpydaJTCrgUkN4KQy13EXEQW1
Uic9I+qSQM8SB+j9vG+K8K+UW2keTA2B3+ciDjEiu6pokp2tadqlC+Z0PAsFV1NLXCl5SNChkKUx
YvfwuoLs2MfHIUOuDANYYBWyoeilvVSUNmaF2vYZtPZuqlPABRRgawFIGsrXgISdXyXlromaoxo9
zLqn4tU0NGH7nplfLE3UB8gi0PzzNagboZ0VyWb9o59kY72S7eR0krDeczA96S/lg/1jCftHoPA9
mgc9tPZYGJ+ch4c29eIftdDnrvvJ2rW5kc9cJaltLY6kQT4GN6Ibwzd+TvcTWrzGh65002/Kbjk5
gRQUAEqObmNvBjErBh2fr+8J1+g2H8FcLyqlNJUb2LkKJB5TwhCI7baL1xZ71QqTmLpAWxN4Dd6l
jdt6zbshDYZHwKUV1HFGgICTZed80Y6m6vVWfzNg9C9xQOMmGoLj+fWtsNWFbTbZAdJgEhMIm4/p
PnvqVRwtkRvkvqVMdIwgmbguJRuGpErfS1WfZ+cBc25GYXqG2f2Oo8Gdde1Yk+Z+DUs1h9zE0VtK
hUOp3AU1cAIwAIEiKOvpqzpuMQtLoKMH/0geqswvn7KvS+eOu/G+jcP0Tvact+pJepPeRmEed33d
f7Jj9DmBvncdC2D301J7ZYmNIjubD9MhJX70AgT35mt0H7lN+fXXdXvlBmAmzu6aFEOrDFsWTWhN
pCmm2bntpr08Pow39s+0dzGF7Erjc9d6hv/cC1LF3EMCQwUvGdiHkPC/NCKLqlpdOgO6Hb5b+/6Z
eNVdnnr0ZPnXleNu5EYOk0cBZEJZAw4pOxvGi7NE+9b2S+es6+g6H9rpb6649Q3+H62Y+8ZUYbRp
CWmd/3vSPUB2IB92O9yOneDAs7WffzwtJpIw6oAn/6d2sWLpnIhIWL+qyL0pwfwyOI2aZJ/agXkY
XiZtl6P89kKtG9U65uiYvL6svDAFtdv/imeunVJaxgiwX9k5nH5ouw7O/Prv883jz+8zjpxYmMAx
Uvy+eoNxTgdMdU55Y1lf8OKpTbSyC8RxY5OtPozPziZ7VMiE5SypBugRa1fWxaGz70Gq4EXGIZpu
Y81Vc9Fjixegb8SyIyuDMgHNo4BYLSTnoxlcX0S2esAaic0Yf1WmGdqBsIpDOAfR9y7UMR9woC/S
V8e3d/ExwXAqUCF+Rm/WN11x5Zs5zA0UonfXv0OkpXp51tVhqBe0A2XnmKSuLH0bhrtWBH7HVrn/
0RVhs4I/ZC/ZpZSyBC5zPXpo3Tm+WfvZM07da+pFp/YhfWqCTKAU17Fs5DFrKwN9345BOHsm1a7Q
HxYZs9v0URtvjPmuUoXxJfdG2Ihj1tCQ0LGm2RCHbjw3G9ziQd8ttd+cLeIZ9X07CnIm7GTap/Vk
ngg1utNkPcZ6jl4RzA8IJI70/GvxYncK6CESeE7ued+ox7wNKs0ccEd8SKvPKwjs5A6/De/3dUPk
eq2NFCZM0lZgeHQagslgb9/Pvn6q9tcFsN3qn1aNiY0M2SjLRIOE/jtgB93+ZjoVQR1kvrYjYbfr
/Wk3PxIRNA2LPfpJLOOOl6LEsziBdeg7ZfDINx3DSNSnYK5CEfboBLR2G3RZJP4r+mr32ht6bnfV
Xj4hFbE3AGkWeXPYCSxo3bJPMcxmsRkXvoyNWeY2tjTSC8gxLDRCFX3hXl9xnhTELMAh+oiTWLpG
WifaqCRSdk5zDN1HNTIMgoPOXVwLWQXVNGUbWRRGEaR4UJ9IHTztwgHQ7Dv9OB6b3fAr3+Xn6Sk+
lWcHmRzqtXt6rncoK36lu+KLFnRBj0mW+jb+We+EqZ31vLOru/0o5sLSIjWN8wkfJd21oRrUPvU6
Nw2S74ZXe3p4fZG5zmAjjR1AmtW0pjle0rhIdJAnrziuPwFd7JXAjJ1BTnVdnLb6livKfezI5oWx
qDP2ooByfQDeu/309ZcC5GDqJ3fjdw30I92P5RXV8CP43/YA8cS1ld0g3FFB3hjvumfbnfbSrghF
p5ulTfs4ZttlYJwwaru9Fsn4Ll++kTDRp3vaAfPCRe624FD8ku7JcX7R9uV3PPqO5gmUt9YDuBS9
+t0EjRieoV/in5on3wM3yo1uE4Ghcq/A7ecxLpsuhSFVBLuE6rb70qx/lvcGIDDv+E4Ee8R9NGyF
rQdzs0d2XOeNnkGYfHQAT6Ttwq+Ae3EzTM4KjjgvfNhKYry2YcSAy1rPX66/9/m9Vv8uRKlKrt/e
ymD8di/JmQ4oShg4vGZyh/ZlgCIn4Qyyv8kjPrI3u5ff162cm7rZymScdqW1kuFQyIztOaz72kvL
NqyifNfF8x5UCUepp/t07B4m0t/ZTnI7jFGITgxfWuadpoCvWrGfl/4OXaaCL1u1vXb+GI83zX3m
0Blf5jwR9PHNgbbvg2IHXDdP8oYAkHxfy6MICZQbg2/Xg3Fp/Tg2ybhgn+VdCii53ksfdL8IG78T
1M94wcZGEMuggr7gyJR7qIcZ8fNy0l1nt2LViUZ6uHaL6SnU020V+VxGH4Cuy7NUxORM0tZvlV1h
VcBSEBx6tufyH5/0R8rHqm7OoT5E1MCwBTkroDjNfitTsrfsvYNX0zQP9xMgUhLT8dSh9rISXFTa
uE8U4ALNXrd2TyzFlxFAdmXf7bSoCpe6Q5FP35NGCuKsDTpLu3Pk9iZq8ieHRGjqF/XickzN0tHV
YSOfjooTmweolREN+0WXnPUag/hd6+pouVXj53J8EBg101GxLhS6vpHTQXYSDe5siQAjkfo0ESs5
y12zr+z8jrZhCkQ9eaeS517z6QDcklyUf+AYAUIHNDk761wX2sEv3SSdMRVoFjQ9x4rhtRhk0ExE
z9Vyf107gRg2XzWDYAAzMh0Sn90xGTJ/VtC4DOTOfy/FlhHTWZguAWIF4/Oxkb2S6Ui8UdhP0Mvv
wlItxxzsrQTG1zeSU3U6RSE1X0B6XRnHwgbITTu/oBU8vK7M6sQYJ2fjXNqYolz5otk5h6hdmmVW
URVW84AMqW/Pihbk0+L3WTCZNN8NYAK+LnL16J9FYvzYWtu+0cd6aQzpOGR4vGL9xiko1cltyRhk
venmTrlHv4PgTcWziZVc9D/SmBeqYtHJUir0ImCKpzO/k+hHJIqIRAoxAZFeRDbtJTU9d9Yy7aLY
cnypcAbPKKb3HsNnbqbroiQ/VyZgTsHuZRkaeGEuF1FJWgrmUJT6FICZJTdhb+2aJRRCZnAuCdTF
/ohhLJHWeq3GFWqnTas+liMmkOLIkzppPy1K0NRSuvb2SGBtum4i3AOgI4HhqPAYKOtcaperRRsZ
1EAzRDb+nIxl56gJqJ/zyiOy+TcnABludCvB+2K89lKWWVF1bDqoCMi6xtPQmq95NegQw0g0GcA9
axtJjFaSbs4aLVGXMRJXiZ/bGHOU5yyYwbYruA+51rGRxFik3Uhd1Suon0ISKQOaHu3Si8jzGP2N
L9wIYoJtGT1Xuk1WQZm8y6pjt5CgaARYc7wo28a43H+3iDH2sRkciSzYokTvd6lqhNX3ZNiZ9lnR
vuXFrgQMMwFKZ0xnzPwJlnL97U/eCrBuwILSHEQYrHnomWQaDYoQ2vK+xA9T83zd1EW/zxiFpUXA
7B3x+3H625C/Ce8S3u+DOgoccpizwbj8aiqbyGiwqeXMXYHbqm6+F4m2HCfVGQRniHdet0KYUBkz
Jnll1NnHGUK/FwGBe6bf2/3v62vF8+UYWFubC5GA+FQO0+duBPQkSc+tc0PIe6tKAr/DOzdIIAJc
D/VyIEkzeswYti3zHouF3JXZzuCcxhDWiPnC4ihlwgcGd2s20pioKCFWH9kEHThZMo7EVaKq8+ck
VoIo7xyX9OoQFDLpvlQZfVisdsAoqzTegpjL8EeloP5Ygi+KLLlgMwWfZTAWby9tZSXj2vuUglds
1GU9JK3cCqRw9xIJKzAcaugLYmO1ljZzN5gNGjY1oEFiFlm4mby7y9lIYE7W0JdT1/WQkNb6U5WT
UJoiNwU9sNkfBl13a1U/gh3zuolyLAhsm8BnwIsHfIZs0kbpEmUtzePmMiWvG8BKSev7vpc9pasT
10ri/XV5nGW8kMd4essupqZpIA925CYDMOLiG4ylC84F53xfSGHcfJLkeKAokFJj0mO6yfvfeXrT
m4IXKVcXeFngOa4rZzOnDxgUGpEbxDSlHe1zIzuormwLzI5j3I6CKScDBH4rcPulUVxfe15C8OLH
mMXv0fhmEh33Es36LCzj9EClJL6nXRXMWaq4KSmrEEAIv8lAyDnDqM7J0eJXDP4vBzr1rS/4Hq7x
qSsupQI0LgwKXPp6MzZSHaMqeGY5+ak0m6Mcf69J9JqmYNdMTNeskYDXygPCmwwsEsi4uHYeAoRh
ZxFyyvXxTc7MH9c/ivtN6AjDdPs6hcuilWqx0xW5hjWSJB+078apGb4gc5WIUnEiOYwzzaKm7uQZ
wVVSV8chV/fyso6JGwelwqREVu2uq8U9EX/UYl/sco6RqBGAB2eM+qPNboj8KDo2VPB4EUlhNpRa
Vl3MCTa0cOXo/iuxXiJN4ED4InQMxSrwxHgEXtqMkhldNLVYNxW8M+N0HAEq81UbHv5muf5IWXdv
E4U0iZWQIYeU1HIn6qGxnQRCL8U92xrelGCZcPCWZYVQUPL2C7rPMBHXu9lkWN5MAPl2XZXVCzEB
IcLAP1IYL4U+GbvUVWkNQo6WPXo61XbRck9lsH1FhtelguiXb9h/5DGGrVk0Qz4gRVHe6E6ZWT+T
/Fud38sAiCiTVmBwV5VTMfxyuU+F0urIxaKrKdOAVGEBxxscYfLXvrojgKgRpqO4Hh+UWKhcOcBV
Yp0DkkUWUkPQDUPmuCfp25g9X98tfT0in7YLcJuIgAEvijaDS40G3Z6qtoFGThenQVZYjR/bwPac
GyK581BmgM8BTLnekzxosoaEsd18nTQ6uo6U6q5S08hD9JK5etf8nic0WcVJonlLOhQezo7jLdP4
3chp73ZK+ZIkM/ExdRad0NxquzTR4tglM7DunSWdX5y+BkiUAvSNZYwVv6o04tVNbrtlM7QBkiKg
HZ5MgHUmXXXWAS0SKPEoAeKrBaDwrIlwlPnL/2dtGFNO7IYsdRZn5zoZ/ToZfEkEkM/1LitBuImm
ZIyir0d2c+7hdeweaVlks40HJT5r8z6XB9cQRV28rDnulz9yVk03csw+t7JKhhzzWDhBDmoIw4t0
xMrH9Kd00KpQYFVco/ojjnGa1QKWwcSCUSX3bi8AVRMtGWOw4HTv1EjBb1foGNXv2uPydv3jRQKY
XTeHrjWrGWsVZ1HQas8AwfVi9X7KXv43OYzjKnNNq7sGcqL82LU7Gx3B9EZWBQdcoA1LmNRXvayA
rgtSnvtb+z79Mgkq+FyX+Me0mIjx/1nSUOUNOj1RhlVSl8qeHe+TH2MXOKIF43r6jSQmnETvgqYu
BSQpeQiEkt4O8C7S0SxU76/vDP/c/9d8WbwZNdZmlM4hyEJddgI2Q3KDwyO4J7naoJQBVhMF2B5s
MKrTscfur9vfPjposJLMHqfSBoi1WQmuSK4+63Md/5DnYGMYKsVlVU4lGj+Af2SjDDsB8VbUR8bV
x1LXZx1SrqjWXLqYHHQIUmo02dkefQ2DfyW13MJKXAz/NaYgXOLaHJKfyFrbxvpauZQFbvqoqCok
hWgRZGkwDSE68KrCm5OgFvU4caOmjaz1gG1cJ9LxYyb1kGW3wJAESel1WxP9POPOVKC6RPqIFua+
R1aIEt3y+zgSOAGuAWx0YFya1GhFa8nQoQSUmPFuVMc6FcFAcvffccD0gslWkGcx+x+jxIBXKxJD
yLgnC0YOc8Vtc6ATyucxF+w/9z5TwWQPuDGQyiBuvtyUGFDh/YKw5ayiWBLMw3JrjY28i2mp+PHc
px6G0250e9b9uZ9qd7KVWuC9eUu6lmwxMIx2HyThL78gM6iFR2aFJV1+ZfGX6S9mRIEW/Of3mdvB
tJO6JC3arZsY+JlAPLLKH40msAtegzCoWLBb2sqMg6N0qYXW5CVynqgI1uMpl5vGQ7b63AHwrwco
ldq4K3ibVaGDBRtKioest8PR6IATfW+lmcAh8lYUkeKKWAqsDriRy2/pq8yMpgTfssLy+sgJNV6V
53cDFT2FuYJQP0R6A1DUnzDVwVoaqTbwBM/Dor4vUekEWir1fopzF1w/3OsmscG1CUStFbPMQSaP
2cS06qaktnoMnFXkeaj7cz3flfIhWVSP0q8VRhmX4i9eKFhBBTmiFW+axRUzpp5MQKrBS5LEYbFv
ndJNMm+OVS+awZjZCYqVvPBiK47RMCk6AOMoCvJrqXVQnOJLXhdoMlAAsSinh79YzT+qsR0ZA3jT
tXmAanb10mOGKRlXoFkQ2Dxq6oMG/iNZNH/AGzBx0BMAY7FUB6hUjE2WXZNmS4rxzHIKDYWcqgZ9
8o+2MgU24HnyzE9OZnrXpCLUJt6tAGQQQBqjL2RFCbg8CyW4FAfQViFb06Txb+TjO08aK+UvfNhW
yvo23FxtcuYsuN2gHXC297WGJ04WLl0dXt82nolspTBhWwF4RrnPIQUAzd9U6iKIO1Jkf1Nd1ObC
O9iYxrEB3weQA5NNcFAYR6LLeC5HSBfsaVH8wKCy7KXJ9Bc1AOAX4dmG+U4ENizWyNTYxRCtbwRz
sbsA8NMJQEEbEcMy1wr+SGE7AdQ5tiRNR8JG0t51vMktQ1TQ+Zi1Yz0UOk8sEBZiYBTIoJcm0JUY
ftQ6VKaMJnDQ7d+F1bMs3TaxW2knp3sHKdf8C9Pwxvw1i0uwO3tFdVDp/XUT4cUOIGuCk0TPCKx9
NaGNIWqL1HdWU2MImBzSERA/1aFJbwdzDrVENJ7LM0eMHcJDmoBqho+8lCVZbdvVLTo6hqjYDdR7
K3LA/w6m4DZbPQO7sBsx7N4lil3Ulrz2VTz3xAXjg/1LfouyOyIa8lm/95og5hBPg2Y0Q4/bjPxu
3yCKTO7jIgVm5IvGC3jHC2VmeKWV5xKX9OXK2SnAmBFHpOe79qk/jIKbhGsDm19naigtegxy0MMj
l4sel0U+W8ZX0qJeY7y10f66ufEUcRQMYK3NXuvz61KRQiqqhKwT2uXUPpqN8Qj02r0hvf+FlJWJ
DKhjhm4ZzMbMCX61y1aFusyNkUIbn6x5EJgZt8aygpSiT0hFXcNhbqh+JDKdcjTXTG3QoGihNb1v
OF+IaXsFUNjzee8UOzPZAeXELbWjJFvhdTV55wkwpCb+NHQgsJgTRG4zdZixmFab9RgSd8IavVk+
KcrWjaU4+dfpH6RdMY3+McOPqTZmVZdeiorawVOmmxpv6CZXacb9mjgxakG48VkxSMLFBZO3VxTO
1Yo2TmnpAeXbtBi7wgMwBcIMYGbktA0mDARG+u76In62yEtZjEUuVOlpnUFW8WLm7oJtVAUS+Nog
vF7Hz02wo1xqU9hSXVIDzzMyotszA8rzvqwK6g5m6ri2RUQUtSJ5zHFeNBwKOvToC5Ew4eL81srf
OGFCxBP+wiE5DjAqPAdZFr6ubeJq0Ge8zqX6O3pX70ua30ox2NeubxCnxwYEXKhaI7RYUcbYofWo
tAu7jKGPkpeuGieeVciuibdJE2cI4zvXdLJ9TjFaQr/39aGrRcxVvAXdfgBz0KVCHc1lwYMwc54V
44ZIN1owilr1OAEv1MSrCPVfzBQ7LKO7XFJdonhUn/M06NraRQk0GTM/BlGj1mAESE+8wShdvQkM
Ue8tbys3otmYt4o1O6LrLFmJWbx8h+YNRZRs4bx3UdZWEbWhOwaEIOwVBtTnQq6BZn/Oeikw2r39
VmMOHpUOAIP4yfxzmv3GGLxY9zXsaE8ANhYds0J9FVjT5+jg8juY02Hm9di0FN9BXt6pZx5b3zj/
iN6SsH5xjk0oHc374sn6EvsCuat3vAwWLuUy730guSuzUcKI4pe4DErdW/s8alc+1OpR7gLMnJWi
PCcnVwOZyAcB9AL1KrTDXHoe2SmqMSpxcuKywxS+7lEQTU0kWHvhzOjYD8D67c/JIngIc6Y1LuUy
/ttsO9CNKFjjypUq924wd4mv3zegIobTc7vHBowOsZsQd3ydfwjWefWmn9YZ0KbIh4HyHENnlzrX
KQEMhwRvq0uGK7c/nT4JkmTaqc4U9kl1k3XlfZ6GQGGF4vk3o5xFYeHncAram4jqAY2A3t6Pk7C5
vVoQEDdZIiN/NI+3covxL4f+QIz12lDphg76m0BjrmUhGYs2RBmjtR/cmBt5/VI0i0MWwAPIlY9O
92MqjbE71/aj8WxnHpVf2+lgOA1IMWXBavM8I2zLXHEQcA+waDit1aCo3asoYd7Blss7rQxyQZGD
u5obEYwtWYhjoshS4P0T3y6IW4KftzZdKe29RtQsuNrGJ9vZyFrV3axkYS5aPFs6ktu9/bNzAF2p
SI/Xd+vzmwHGAfZ4kPKusBVsrn4u2wHJLhjHgqhQ66QAxadqAK6a8p5KN7bUu5XoZuF5d6D9Aq0I
6OI6zsSlVpq5zHKymIimDBx/8xswnhS196/rxd2mjZD1/zdLl7VVvei1hQdzAQaXzDHjYHBkd6Ek
c2urS8BOXyQCmVzrw6TIBy4Gkm7MvdxmNu6PwsjOk/pSyolrkxdr+lahCfHf66YDpQjQlCZQilgE
xxTAcbXa4oBN0MRHl+ZwniNj8MEMkXrqSH4B7UERyOT67rUwDRy0Nfb4FANHYE0pHNzJo3lqXqf5
3kwwkJDGnlY63pQf7eahsARnjbeggN0H4L8KM4F1Xm4iKbNh0Gwc5wRwTJIXZUhBS/d6pQguCJ6x
bOUwxgLKsMnITcgZpvaHXIGWLNk5rwCvDGcpctzru6fjo9lDDW4F9HOu6WAEIJdKNUsNlOYuJWfr
VQG8Qi34eV48sf15xj9ptapO5ViQc7N8G+PIrdvJraWnXjqqXeLNIjYS3mHeimO2qEb0hObXEuNk
o+FW44MNqDYhyCfPSW2FMPtDnS5pchAgnLPBAU7VfTTmvjI9GJPv2AGJ0fIlbKRf06rXdok5y6XU
TVNbQmRc7cp2n8UvpE1c0Iq5Uvva0Z0CtthFf7huGlx735jGug4bp1UD2nIqupwg8QE8LuUREzmu
ooCLQxiJcSU5KEvpYC3HU53JKvdUJVG3VASwcbvWBO5Yl7vx6DQuwpO7WUp3qWEG01h5LTmA0ixU
iiWongxAhS1ydZKjXnACeWYESEgbj1IMWKGWe6n5pOSdIRktOc/yjaU/44koHB/gqfyRUkQpDXzw
rMq6BBarKTfIGTkJVxl+5wXAKSjYrRTR6vLMFaU0JMDAAI63BXPCZbV0pGYxybkChGNyiAfl1JXx
KV/nvsujtpAvQytoCOY5FdQHkJtAAtf4xIszWNosU00n51ab3AxvUmEDGmda/INlAaHCSuKIfqTL
LWpbcLKlDYqCdnyHaXsvk27WKVHwVBTflpNSY7pKQ2kCL1I5oGPYm/+6PA75iBsA6r1iELIFmCaR
prpYH4Wkt8swqaXn0on+fWLzUghzAvUknWPg4+FVGJWhBgrx1po8Mf4rz9w3unxctpuDHtPG6WwN
D6Gcqod4ekBuEqzaIjvkSkGTpQq2KEy0sLFdXTujvXb8nLMFgxqlggbcplS+S04vgnfiXTpIJWFY
FiDJ66DdpW3UTr/ytSPyqSUQoebOLnFQa9cBO+wifbzraSy7cZ0IuC25JxqkSYDxhDkaMiM1Tg2U
qOQ1PGgPs2SdGgx/9Niu5q/UAzkTECGRWkKH9qV6GrarLVf10HS/zzRrDwwtI8PjJtXCopo9PRGF
W9yt20hksgIyxmaTykCM3JD5oDW7fl4OsiEIr7i7ZuG9hGFzHeeauQSMttFA4Af7IOZXzM7Q0IgO
yvjS1Lh8WkFdh+ug1sqShgy1Dbd4uYQd2E4LlH2Q0rHG7j4uVOmuKpo+uH6BcjWy0TqPZyeMkU0J
G2ZloUsLsVWPLONa/5hH97anwNC5Loe7PRs5jEHI1AKHLED/z2rwJruCu5Br1hgiWWFIcU2xbXSD
AY6eJrGR11YxZakuXjfpLuLeqhCEGyxNNuoR6or1q6Fsv47/sPQ5Mk7touLRcrbpaL91EjH8OZoc
D70zyTFah1VBpI20QbycsyZTPQBrJK6u9+apHqQAuXfTl/NC3zeT8pxIigXQNTUPayfLD8qsYVY+
qhcfDLT0Ne0mIwROhezaKTKk1ZI/DkU7uhbpkYpJ1PpuyPAd8QSyAnOu0/2Uj6lXmWi5kytzDtD9
Q3ZDVSSnGL/sahmaoxyg7gqWfvUYbNQHXFQ4K/iytYRxaaUAeW7syljIeZLI09zpT0hlmA850XK/
qePkLZFaQyCSe6+iwxltGnhcaZ+qkG1s1maqTYhLQIfhKwBF8ZxX5Yv1St7ln8UvxfKz1kMH3XUL
5mv6X6lsUTItFCJrGaTWfuXQ42S9xe27pMWH0Xi+Lol38gHyDpLatbABQIXLNSUG5r3B9w79GjQc
tjL50kaNaBF54TrKxh9QAACGYONH5LhapZdmgoEodT91r8Rp72W0JznTrnH2RTm6ct64ffrlum6c
mhvutY1cJl5I8avS4CDuSiqpdkeQnC5K2tzVRiSfiikGZWgZZxh7GWd/tA3pEKnK1zJWNH+ai/qA
loFEsK/cd/rmi1hcOxtdcI2E8bDzjLzU2foRK6H6c/guu33l21QgjeeqUH9TMQyODDrQTy/3VqJU
6foEwuIMI3vtIS8w/FsEPdb6+kLzBaHjB0kAlCLYmlWa6DNx4HXPpgXELgyFgxHR+p68X5fCPRTo
WQTcB5jvLHYkkc4U6J8t/JDl/gCgnHfMd9cF8A/7RoJ6uWBz3/ZDicYsVPe0FKB83R4oJnst+AVm
H1/ybeAH/Y8StUuJuWGRbBgHgChbP9sASb5c79+kstsryR6t00hdzvaNMVSuBn4AK3eH8l+SmX3c
Mmsn6H9WlXGqedwb87SuKsArfMCpHsgODIkiC/lIK3/y3Rsx6529ialnqSmijELMBC/qgpNy17jm
LnXjb0jxuyE9Y2Ar9V+RBwxQBvCbQ3w3BM/vSyBq9eMFIUi6oSCNgAZPFUbfQRsAiaJGuFWbxQND
ndsCTbxuXmY9KKiJl1klOBy8aAQhMJJkQILHq5OJrZAmTHWlyHKMIYMRw5HTXxiwvC2IKE3GlWMg
TkBvN8bj2dtxbtFGgAYTyKEPU33U7QPgVa+bK0fECiuMVQOlORITzCZadMnzphrzsxwYr/kpESHu
ck64gggeNIhoXLFwG10aCUpefZ2CbnvNe+joGtg3IIVvPTX691tyIYfZEqoPIJR0hvxc1L/RYw04
BGE3Osclop0EE/hQBJPALFlrnBJiS+acn+vcCufhZh1bpfK7sMOauyWmszY3ryRX7JB7EjuSnPdm
fh6VnUFvxixAI85f7PpGxFpR2hzd2M7tqc0gAp0rtDxCBDDwr4vgVe3XHi+0xagrfBQ7ZIEcbyfl
PXpwop1xisIsxHXtdt68//UsenfzooILWYyXRxp90BIKWVn2bI1HEJ15C5pEHa1y5cQvTR/Q1W0V
jPmjlv8UpTA0rmFsNGU8fhr3pdSsmkqJ6/y0c3DGxbfDWX5eQqRovfz0Q9l3/nTqgjTs/f4p8/J9
41fP/a70tdMc6vs2QCEhXYFbn4A0J/TUnGDtYnkYB1maba0V6/K8KL4cTO5yUCHN8ky39SL/tbqX
AfPy4rhJcN0GuJa8WRjm8IN0Z8lqxGfnfIx2rRGMYEe3l/C6EK6H2QhhTv7UO3Fu1hBi1F8QXhfS
ozy9Kt7sCAz6o5uKue8uVnH9kM2hmVK70o1VG8Xv3ea2PyohyJk9De+Hyku87KDsyW0dLr51MsEs
q9x+o8f2kACRb6f5gE73ZR+kn+Hi9U/g/lLD/EHxFi/Zz66Jlddc4qehGBNz3Vv2q9dS45p6xv3I
ZhFrJ5obdW1krWIAoM6Lf331eV0raOXDpYs0owEIYOboJZHcW7kEMoUaA/2auxRhRDB53L3QPIgb
t85dUHTeFZbg3uKdua1Y5sypJogujRRqWZkVdhOGXciknhWz/24OSSFQkhNgQEcHnWjI3q+A7pc7
b8KMY82AjkQ1DxndIcumlHGY7x0jpJYgZOXZM96mSOohwgBZBOOb9TSKjHqdS6Vt62VyeUJuO6DV
QypPwLH+9xmpdV7hv8KY3StyMDdEA9q2tWS+NSx6E/dvpjX4adu4skLCUReRiXE3zgFvFaZuYZE2
4xPsGDm/usTQVUbR2jfXDUCXTcwrla2uuBlmQ/bXDZQvDwlZ0KwDRoDlX3EyQJE5A8aVYuXw7ZBl
iNemWvQaXq2NPWRIYaCYgjotEkmMD5LTKVbpOpFUKy9yXYcD0jZq+qQ2XxP9MPaHWE3cHKO/Fnlv
9H3Rvl7Xkednt+IZzzSX6bzkUQ0OhchE226F7FW0PMVN+/h/nF1Zb9w6s/xFArQvr5Jm8Xgc24md
7YVwThyt1C5q+fW3aOBLNAwxvPFBcF4MTItks0l2V1ddt8Nfl38PExVwnnZGtkfYdA24jxIga9H6
ZX2zdefWyodjRz+Z/ktrPJQ53bFBRTMhH9ofk8LWS4AWBgAEqCn0S/QxKNZe7QEYP+q2irHJth1K
Eb/HJvhlYlFtNSiWcMm7w+AGcbOwx8Fv0shy21CDxsD1ueQffm0uBZdZM42gKYz7JZiMMvvj6P+8
bkA1c4JT6NMYGIQbaJ6cMY2a+pPtKIKwyh943NyciG2OFg3Wwu+qEfJkJehgR5xy+gOI96yihK7S
LwsYr+vDkq6TgRYTbGUdaqHCOi3IbmqmBRBy8zDjFpNExXQsrHBoXq7bkU4fEoRIB+Nl9BeLIWn1
gqwcwpb33o+FsCIiBrmbZxVlp9QPLLwnOIkb70m+nEOojjt+NXC42vzsjkfN+fSOcYBeQrd9aC4Y
Im9Ylo41UmLAG02gmqIOkCvAlepMRTsgg/yhM+qPHe4rG18g+lJo7oTahmbAFNnTAkyTaN7/hTTc
YfJMwGZaOyo7/xu6q4aw6h+cAqhucz5TLGaC7tjr45bFfRPBGFllk6OuBd+0tLldiolXyJArdG6Q
zl+L0FcJAcmt4PbJlenRCSCsnmbVgeZAtJojg/vmx4AnoT092IXi7il1RlDL/c+MECxo4k4DaJVQ
OAJj4pxFxYx+oFKFW1RZESKGN9tLldYYjAWZ1DjT3Mcxq1io5MqThg1ou8IjQfaLutGlq2AfkHVF
ZIA0Dglu8yXwI4vOTtwWFCWIceoOXdD7N7XZxpoBJenrjiHdcNjPPnCxEGUT71fFQguStACqsXPw
w1KFJ9lVEfcA1H7RoQaFcfNybHkKnIdFARUry2XXecNN5gzR1LM9bZ7M/lD/OzEZryP+sSccycEM
ThhPgz3PAiGDBpkmFBPd5sv1OZMF3a0VPqebzV03vVFB4RQHvztjhYK7tQ/u3WE4saA55sW/ly4B
j0Q7u237vA9T2FToGgqWHP/Onb3q4BZI5siaDeXLRfYqRgqPszXimo1q+eWgGrAYDKWOyNg69d7W
j1odd2bU+dNhdat4KcsYrecxKI721ydTFjO2doXN3EARQwMmEw2M9EPADgPt9wGI+FC5u25H5uhb
O8I2c8rCMOuWR36UZT9Ninu1LFhsf12Ir1owVQPjs2f2ZZhrL3qi7/zCUGxWqRWc8mgYhMybIb4u
p8bJ29nRsFmD5jChg9WlthruJnXvjRVxEwVgQtZXEME7xmcXEiWDCWR6qe/q5bW3nq+vitQWpMAR
ekDWgU7ZS6/T0DJmLyjKnQHNckLLAWm7VWR6bHZJfsAFFGz+TdEfrhuVTSOIq3nAxRltiP0dSUUM
uBnK9Ib9ivpRVEKy912HlI1HFtdFDfhF4HJkBMOljQ9k4mwbH5ijf0gG58O8BB+vj0U2gbaNDmMw
Z3nAoAiLxShli1m0qBktIP988exzlcTgj4uL97w9tpaEAU0MOBjNxP0BfneTpiEUgK8PRbosaPcB
OA5E1vDvyxlLJmsemwEGWp1yHDh0j+Pg33muoG2wMSKcSG6p6aM+AnnY9DtS7Ork5FWHlSkSCdKh
4EgFJYiJtn3xaWgxGzA7feLFoJ3efshpFaU4za/PlyxyOmhxwBOb1yQdIeYUa00gAuQAdJfuwPUZ
kCiwHwtzd92KRCTVRDLrjxlhi+pLb/eelaEm0jUQ0GHrFHWr8c1Yar0PV4L2Xo1SABTcPt3NZPSj
cfCaqLaB3dcHcgJAqYksb6kOuT1paOVygzBBhiBm1grm9ZmBNWWx1qfrXy1bgM1H/0VaazQNki6Y
m4mdjfZgrTvDVZzLsrsNqBjRZ6Lj8ob2lkt3HVieJ6zDkyhxb8fxGXSo92bPwoBxfYrXyeoUCyEd
koFgwin4oFMtLHerJzWowgFApMGQx2xw9FsLEOEw6HJHESBlZyU4QH+bEobWdXY+52BKPfc7b/fv
+jjwJ4MTdIPnT0cP6OW8reU0Guh8x51QT8KeelEKKY1gUrwRpJtjY4XHzc0drbOAGiptWOnNKvaL
5uQsZRSML6s7fnqHq8ENXEwXDIptF71pGM3CpS2H7MXxHlFrU9bApIMBJQEKR5AF0d2/gtbYLuWA
K6CTPy9QvPYg8uoGj8rrM19XMQsDMdDfdoTDxA76QjNX3MXoaO2cJotsrY1aDWTtsx+lCyRkodMx
p4oJlGFGkJN3gY4G8wPOZOFkWbLE6ZcJl6fFaaK0vJ+gPpM00cymo1tlkEn7z0y8CNINKleU+jne
JeiNw4vV+wuhWpv5bE24CJR5HrXkV4C29Xc4x8YC39QbN0QLr92lPR53M3kGZysxQEI7fr5uQxqI
wKUG5LWHDj+RJC7NXHdyczzh/OqgQ0FSCy1jF/T7fIlmlYyk7LqByvhvW8JS9UByLJkGW0Xjg/pu
Cmf7niQHz0Zbn6PiXZcuD+D4SKSCHgHdfJeTl7pg4kwWXKH8RNdDnVYPdV0quvgNmc/jp/HmAdgR
MU8w4s1uNw1dDgyR8xgAoQTtWagw7Gf/RTN3Q/3Z/pTbkV5+Id0uX0KnB/oPrjnHDYjgC7PaX19L
2fyCcAqbwUSCyhIfzKM2rMtcon2G6eiKpY8mq+MlQKqGPk5ARl43JjtRIDFkoYfJ4vhlYeg1ATs6
pL/h/je1DiK+4A6MF4oNIJ1ebGwPNAkQFBJfr4sRNGQGieV5HLRTnqN5m5a7ptPDgqH9yMfFwaIA
ZDrarDAscx50QZhgE8M8oqpz6TyDWwxGC4zhWZ+qTxXWbJqLm+vzJ12sjQkhXBYjBIY0gjyU7keQ
Wf6EZvjc6qDtMkazZykWS2VM2HnUB2GN5iCDZ5X7YmrOYJy0umyf2PMZ1LkKY7KQsp08IWxp42z0
OeGIc/CEOeUau2DYLSe688iHvkRXq6m8ZkqdERU+FKbeqBS5I20iJa2DDjjcHiXrHnmOsFpoPUa9
RnGX1FNT+1K5VZeHpU+rKtRHA71CudEPcb3U5g+bDl4bZlDmasCEkI7/gWSwf6BLkeVgB1iyfbOC
L6gm3fSaBB1Fsb8n+lM6exnhvfXkYSwNn2Bzsy6704pyVlwV5WMDqRAIQ0AoJ1550PlQFGPDY0yJ
/JARJsNxMlSZPKkRG8IhwLmiB9QXvJEka6IvSOedNQJtyRVttG2o2y/XXV66q9CCyVP0eN28AQy3
q6SVFV4c6EszJ5LdZt667OrZUSn9yO47iPecXiXAfSQQfCH317HzDTzS0EoxTjGhu9U5DYZi+0rH
AroYD4KsKG0Ewo5K5x7MoB7C35qFQTQ+XZ8p6XJ4OqbKBzlXIOKWwDtcZD14m89O8FzkH7y0C4dU
cfJLR7CxIQRw3dZqu8rwYu4nCtXvutLCNvP7+PpIZKhRlJiQogEoHf2+YmpwHTSom/NuvWbdA9b7
1b9bQq4+tx470NEUH50jGD0jfTyosNuymMfFnhwcHEh/ioi/eVnSxS3RyVZmdNn1ydhHpVetNxpb
61tt0s+mA87E66OVrdvWJv/7xsONUa/yfgCkuq2m/ao3dxSp676bFZMqHxrI/MD7aBpoKhPMZH3f
TRMQxaltxcTP4za3Y1OvHoJRD2mnoLSS4lIgNIHuNVwuQMPAP2czqkqfmN0kgOGuAZoPP6RW3J66
audqp9E9DF+PwTu8H5lkC37DscyBMIveXCVJOSBp0NYPaG1GStTZaXmtWCvZJKJ3AWBKtJDgviRY
aTKrcijTsFYOeJ5A8tBT8DDeMp2em1qlWs1/THwcAWyOphXQafBiyeUU1muGp+QKsDnJWYycwjB5
4fjv3MVw940R4daiuS5BtsXEdameo5x1Ibg5VujuEOLH1vj4764OAhpeWnD4xhZ8sF7Q4A7BB37Z
7Hjz9Jx1IZsVfZPyaftjRPC8vA6KCfz4kBUFk2u+kkPGnNjRM8V+UpkRsiOBVdYDGg/AGTuGc3oA
KVGluBOpLAiHEqPr0icdTyk5edQwB5fX/pCpOAdsqZf9ni4xcbUkzpxYLabLd/qIjX3YrQqYgnQc
nKsa21M3EX0u/diZiFMTj2+aHFy+wY88L0Drq7r3S624oPQAGRwHhwvrYVTtEFgaxuHov6ruLgE/
CR5wiju+yoiwJE1WQper9NFGznuqnTu6/D+6/2WXEf/PSMTG7aLJuNAvXxHj1L6U5NYAlE/hvVIb
ngWeHLR9mLgmXq5JTmwc2xSYfZp+scZflXWY0nNrK1ZeZUWIYMbiZ2k6pQjKxl0Vd7mB6/QDY4qo
IrcCHhL0uSPFJzZBdgwvWDNHOwC6WY5meiqGYG+Vh6B+uR69+OL+FY+BM/ifHcGPEz+DREhTlGe0
kUCdMtKbHk8UCCV5eZhZP0rwrSovXKqxCXfsekSleygocuHfAXEYP0AyvbAThVdLseK8yQgcK/ze
I3rDQCFl6GAuwOj9sPKGMssMtf6mHKI3LjA97O3XZn1qQYXdWvbu+rTK9lSAupj3BuBAPfjSFe21
wis9AHS4brgSRNvdednn6yakCT/k3ABER38pZAD4N2xuI26hG32Qo+rX2ATyyXp5sLPlg8f6HQUm
fbkfnSQEKBIPskqx0SQPW4ByccBy1lAUuYXTaKp1qxwTBL+1/gYurqkNHWhe6ICPxL+uD1LiKoAv
GciVcUIJcGJejnFNjXSZ57Y855NzROrPHtt9WRwrVUZObgcjAVETWjFERHO7ak3eGl159m3tebb7
FzZ5N9WSnGo8RxWeKfENjOmPLf4tm3VL9LqlRTWUZ284OdkOo0qZIkZJrnQXJoQFMtvCWWoPw2Et
DkCaDSw0rfyhK4vHYgbEuFXRlEsOXAAdOaUirzsCO3I5JmpZbV/b8EU9/bJ6Y+irypqSOHVhQBhR
6Ze9NQ+4N65QLh93rbkcEnrjPwDMuXe7/mCr1GvlI0JqGXwmqBeIQqJNNzhGafKLSuK+aqbzgI6n
p3c4N/AePnguuRa1cF7NweppM1qscduKqp/NcJsEx6RR7FXpOMBbhzYj9P0AP3S5MnOvk1bTEeCr
mR6Z7+xTlWKMygL/+8afVz0JSAvhrLMPpBpqNwNR0SFJd8xmDEKkQ27eokAjl2fXfGwB3ym7nyim
vmNbcpg1xC5QgoIbXw7DyaGbnZQ4L6h32/wYgxtVS6FsnrYGhFG4U7PYUEgsz+ggIlY4FYqrtWyL
oK6FrgJUuDghwOUA9E5nNsrEGIDOOG9HEq1LcCxNL/SWDBDCR2PRPzlmevx3L96aFXbmvAzlVAF9
f07Jnd6/ajby35ALSVRlJtl5h3fjn/EJZ+qMFFTumhhfzjUfSWVCcXQAiRRzsofSuS8X437Jgu/V
ZLsophOqeP3LDr2teeGanBhstM0G5jtyv5ZPbJrCNRyXZrc4ddQThTXZgQQOAzBNoy0bhTVh22as
T8vGgjUbwghrH5p2rJWnylH1cUntQFYCFiDU+pdiCF7KRmoHWD1gLNbxhDbHqjxBrfC6j8g2MM5v
ExCet0SNsHQa6A+7ZMUxDhNkesRIlKVqlQlhecrU672E3xRAbYHzp/C+eMi6+5XqXJBP2O+hiHwr
hRdoie7jaAVsFtAXOkVruw/eFYw49xQnmMPiiHu5AYgQZNXlefCf/cSPEY6mRkW4IA1IPCMI3CzI
vi3hcmUsWke0AVNmaVoV0xbFEC13GsXay+4iON3wevWwQ5GquwxLy1CZtQHVv3NvuDEWn+gPrXHq
KItNVR+QbEB4LaGG4+kA7bxVKTcnEdWmyqODUZ6Dpu5iNMJDh7guFkWclXkaALIG7IAS4y9Ykraa
DssIenbzrJxDi3xbzSwuA3BFXt80Mk/jPFmgTuQgEhGU1rABNCalBY8G3udQQHLAijJP8c6UDgap
4bdqBL9mX65OadTdkJgmdiauIexzr4NfQhHKZA4A4oD/mRBZShardNPBxKpQ49R0+RFtzm5yMHQv
CgpVLlPmAaA2w6UK/oZHnzgcKyva1WH03LfJHg8vnna+vipSC8iTYu1N4MJEao7S1PBmTnEX4UTo
WrOE1TvAdaa1sSAkGGjDZsd6ex73L31BT9X4Sy+fE69UHNzSA3VrSNj/aeJlpl1hKAA7kuS05LH1
6Dwjz7ywvb3EYPa5PnUyX9vaE860fLSCqePXOD51HMfRgW1U8fKRbRq0iaGrwQRxnyfeqf1iXEZ0
iZdnk1gHrXPDok/36/Cd1Co+MakliJUB7Y/9aYtP/JbWnTcaCNGW/rluHwJkFTLQgQRUxfIjmzZ0
wqIP9k0sXISspcFAbMMG3QHei31m3cAZCuWxJnPrrRFh4yAKFE0+IKglroOswakfVAoq0mFY0GjB
f3jxiKwQuT0SNjJYmCBTMKAm2TuvSjY0lRHh3LQSQ3NNirmyMxoH4y++QYNpiv/dkUE1+3sowpV3
sllS9OChPDdVUscl871o9qGGDSlhFbqEz7uQnzNtHACo6aPnCEmXy/jcLnaVjj7iM/vq/io/VWg4
Omp52HdfVMUmWZhGS7djAL7D6bf51G4Oz1IngVatOT0H3erGa9VNP/uk8cM01bXHpapemDuaiogg
3UOAYkJOhQu3iaUnqP2CB6osKI5SgtLnDKZSCEpVLHan1+tLJrMEnRsTi2YjUSE+5zMt1dq6ArWR
4Zz7poI21iOIp8EDq6AzlDkgoF1I1aPxDohfYb3mqWtYkFQU8qkgyPrR+e9wve3vC6vUVEzzO4px
6N7tWJ8Bu06YAmchc7mtCWEPoU9rrhqHwkT6ZZ5ui5d6ugVGNxqtV5QGIiUxMJ8S0cXR/QvAJIRv
QG8vnHdgpV0qy28p9uwSrq4dju/A9uE2yFOlQMbgJiIkWsweCnpJhxEVLQnHot1V7tfsG0j0fa+O
1BQ70oMVwB8OwUFPAcLE5VaiK26eDa1hj/QPPU0fa5QIEh165rmrhXP5I6l+TdnegI76v3v51rAw
lR0DNRntYbhPu4O2LuGSsT2hj6UKGCxzc1DV8u5E0Mj+RY80ZA40DgK4uTYevPpExsN7Sp5cLe+3
CcHTIeyxzj36qdDHicnKomU8seTX9flSDUNwdbe18mTW4RggQwJhTZndef8uYodr4mYYwlnhlikJ
Oh8mMFPok8BM2f+uB8xNcHQMMuUWFuTS3SwnT330NFK00CfrHs8wI+os75ezGMnu+nzJQgPnccdW
Qj4eqmGXliAZ1xgVgyV/Hib0ZBgMDzkHiOKgm3XQuifD3Ujc9ri2g/F9ZaaqsC9drz/2RThQU2Zu
7ngIFa7+HetFiuf3rRdn2sX2RdAQ9+6QaCWvY2IL+U3kgzu7XiNb1RogO40AmfptRNinmj/hCPZ8
es6S6ZAkczyxx8w3H5T8UtIJ2xgSrvjgItfdhTqIRNWOd6Ah8+Kp6L5kFwfwPgH/zQV8DRFXXxaQ
V2odAtbAVA+77q6HsnKla+FOcfTJEnA4I3g5FJpGf6fEqjXwes16G4tmQrMoTD/5TxDzVp5IshFt
LQmHuDO4feUzGyegmcRp9UzaX3bJ9kMPJn6meoXxtRaPP4hocOgI2s+AObzcUxMQ3zYCLIb1C1Tj
K1otbq34wR+jhYTld5cqrlwyzST0sP+xJwyO0YxlRg6XsNbx7DEXfNJdHfmVG7pDulvQPgBE8XyY
gteiL/bpZJ6G0fkamHPUFio6cOlE80Z63ABBwekIY9cJmyD0klbnUT9NqbUfexJ51e3gfCKTfXM9
dkls4crO+5WQUvsbdJk58+KjcxWMWk3g3reLDqmUhNJQm9CQ5fW0hvRGXSoCpiG1Ckg8vwaANtUR
NqBDvSGzki47o7klIp9rZ0/dcA7C1rwHT80usLIHI78rNQZu0+/zhIyy8cWox90Anotq3F+fAknY
sVCeQ0YJHM6gyhHCjjsF2ugw6HKawbCv9k6fhq52yFoVl6HcDs8m4YjA2SfcfyrHSfXKhE7yTPJ2
j66bPrTB279DP9Z0RJtbq4gM3GWFLYTcNXg18EBCRk6832laPyE2QGp6GdGpvhakisfZMRVWJLH0
woowe2Aeyjyw02RnC53PVbdPs33llgovlRoBEwlHlKHrUSziTI3Xp3YHndGhqw6e+UAb8M1mihgg
XZ+NEe60m6deQys8732GIgp6Q/MnYr1C193690wMkv2cnRpdJwZ64i+NQERnbQwPI2GmdSr03eu6
RH5XKJKLb6+Dv9Z+Y0YIIdniLOZKoCKdFGlUGKfCvc9s7dA4SzQN9icw3UPe79GonhcdTJduFPRz
TNo+ts0PUCwLu10wg+/rZVlCzz921hF7+awV/U095cDG3zs3QM/uxkbbkf7OV93cZNEBQFK08IGW
EdhL4T7FzAkanwbENss67LTb9qb4xl6bd6DIsOt/WxFTlrQ2EzbYsIIrKO52UVHgjTXY0fXgIh0L
8hQAXqIVBpTkl+s9UwNVZm6lsiKCAs8KZY4HMnyxvad3GPJ0oKiRIwb8gnv3xnuN2YO88IgSoAM4
9UPpJz+7ITPjlVDt4ICdPPYbHCPXbcq2JY6o3zaFHbOm2lT2IwaHIyNy6ctsnDIV771sV6KbHi1U
yFs6aPW5HJczzBMS8eBNQ/EnHOgdOIJq75Dsr4/kjVhO3DDoV8IJgDwcEqXCUIy8bMyEwky7sw/s
rB3BtVDF5KZ5qKPpUEHbNvRCg3NMhnSf7ovdt+cvXWSdntnOOSYPoDE3w+nGO1QRdk9U3BTxZ8gM
RvmhvGGvim/FiK99qlA2ZAvUmzIPhHxZhbtQ/yO1DtcNyEBi1nYyhA2ozawvTYLJsNzigHrc3p2H
kOlPpdnuZmoBx3LqnEebxZ5Xh5WqwV1GcLQ1/9Y1vnFlMhVJZY8YoPnoffWycFzD/jvgl8Wzf89e
yNfhZf4Aouz0ESm/6yOXHZlIibx1vaP0K2avE7tjel6CmsxrE/Sjl1UTp2DaVWwbQ3Jnx48jG4aj
DI0oogyCS6oWB3YHLiNt7+TfIT6zA+XQsRnDIrT7LATDZIiCYLXE4Fv8aE9H1CDdgu3R4Zmkabwo
ix6yKLX9IGGTBXSGKGmCjmYPhIsd+h5mI5pNL7IJck+z4jCXD59TV2CnvTXnCls6TamejhXcq1+i
hhTxCtK+gnxN/bAY76y76sdsgrSb7SHRup/vjI/6sk8MLhJRMhVESzryzbcI+77NFy2pXay468be
+t+kgSmxPtZu2IDq7LpzyXpd0PUIrnBUfMHSLHKDlBbqs86ELnuiP1a5j56dISyMO609kcXbkyQL
yRB7wVOT7ebmuHBmw4kpMrHSq/f2I4T7mttkqAYYaCnHC366ZYha0QoyyjCrw+Rp+BXMsfE9Dxc0
PDz1T6reP9mBsTUu+FkK/ItNuTjQktCY6yM6btR3ivDFo9Nf8RHZ8zc51gC450v3CrJuaecVIwRp
Py6+pnnixMv0h26dGXsBtGN3fV1lJxT6UIA19Xh2RCRFd9amCioHy4pKVJuhMgnUZ1Yj76NCJsgy
qNA6gto6T9riWSDc6pK8IRogeGABLFhUpR9bw4t4NY9kTRQwNHEgSuOR+PH6+GQNPlxkFZcYlEGQ
2BTuMNQqco+maHedm2DfrmW0lnvS/Zwg8Xcu8uAuWJ+Naj3liquyjGsa+i0An7n8noZqyOVCGnra
WOUEEaTA/C83ZxQS653jZOFU31ZpEnepDSzXEg4JmP/XNXSz/og3liITIV3dzUcI3jSTKst7BwQC
uvcFiLtoAk0BWj5vcpX0tcxt4UKAqQEpamCNL0drzdTxRzMpMNrYH/brC9etY1H2n4+9qHgfyM45
lBTQCsLZdiHkdmnLmF1wcK4unjqZ81o33RSlWu4pjjnZKefhDEXXEZIY6EO7NNIX00pxpsBtnJ05
P6btznqp0/Poh6OqGCyL4ltTQlwBAA512gampqj+bJzLTw1Qo6rwzb9XjCtbI8Lus+t0LYoJRkCx
+H2cwoZCRyNfQzOP0BWrYnWXzp6PqjCol8C/+bY5NpcgL6/93E9gjXj6zWLz8nM4PyazAYYOFpJe
4eayyAx1eY93a2Gri68hz89yjhFC0JysLKpacheU5S/SEdXhL1sqSGRD7A5VVZBLCV6xuEkSFDr4
RgarOzoGiym9XcFMDBrv9LZczklbhZn7wQw+g0C4m/al7h57FqXrU2KoMEuybQA9LdR18UU4kYUA
M9eT3oH9CpxnVlPc+N6Q77KkNxSbTbaxscmAoIVMNrouhAhS1au1NLMNHWJGDmmp7aoMcP20jwNI
QA3VqW/ZY+41ioNetqBo9jHB+IB7Bf53uftAhYPmDxRBzinzI7A9eE0RK49a2QRujfC/b5zUMGrb
mIChP6/dY7N+ttNVseneSKPFTbe1ICwRWTk/bY3JS4P72h1jgkZ9h9YnHaQSlbeGNOHPagoN2JTe
58WdhhsrlELytjg0dJjQ4maHeOVDkCADjNP7kE+7pFz3tnXowYRtdMfB3HuZql9e5uTbrxaWvFg6
Dc3TfMkhVlTvktkPSfk9K6OhUIU++TqDVhzKooCy/yVJDr7kog5wSIIJAHglqAkjpVga++t3AOlC
AyyP8gxuAWhouFzoFfwJrCBveoQ+gOZZpBWKIq10HBsLwkJrvbHO84Apqw0AVSc38tNzXangSXIr
UPlEJoY/9IRxjIld0rHHrvBmL2Yo/fAc1rwcrs+WLHZDBuC3FWEsNCNtCvIBcB2tdyZx4mB6RdGP
QU7dNONKT/6dgBc652iIBvIO4jye4G31tMw2DcAVklUfkM+jc3E3gmUTSL1EsR2l0wdYFdLXkHRD
ifvSDbKOFFVPQKHMqSgX3BiC6Vkt7sm/9689v7EijAdDXWuPM7umY7Mrx+XRZ7yKelp71XtfFpp5
ilGHACZq9jbfx5v45blFN3gEC1VCKLgC7KF1Iqf8ilaNxi52BtshQ3rdNaSRYWORu87GYlZ5iZZm
2Eh9zWJimvslaJPQZ8mxHtIvHVGVWqSu6ABZBvAksBd/rVhd0LbgtMlF1QXoXu6c4+z2N1VVNGFb
Jlk8wZ8O5ZyrHitSV9kYFhYxBRPmnFU4513eYj7emfYrGq3e44/QR4VEkCXTTgNojqwEbLkksA5A
hBbIovTu4zuWDMxhqOEi+rliC0xC0h69YogZKICGo5XfzF8CtuJUqQ9BoVKLlhUiIVnKmxyQVuX9
zZcOYleE9YOGOOg3WZga6xF8lQFeWgwV8TJMoX9yp59oCCG68uC5O0/Fzi/ZfECKAsKNkeIFLSbf
0sTSDKeEUHeuIf1uJc3XNm3BaT95EUlqxSVFagzJVnRgIWmt+3x/bnaDN3ZzWWigfJn0pYrnrmRR
PVAr9kGctsOFVEXcJLUHCRV0pfH1FC98WeE7kzMNoECYLTS4MuNElz7S12pnZul/191GsgGAtHZB
qmfhUu2LGWXa+majY/OhXI7ugaSckVZCc3xsNyRXvLRUpoSg0i91nmqgzjkbBBmAbAyNOQ87Q9Wv
IkvMwjMRSzilLphnhT09JVmzoLyA3lr3YxaCQTwunoobPST39bmJ2N45aVF9oymeDJKQeWFVCNK4
FuQa1flNCto/XvjqHYr4+lLxPSUcOFDsQdGE09xx9ZlLN9TKhdHRQ59mNzHQz+j+Hl35367bkBw1
ONLQHWwHeGcF4ms4nZLKaxx0TtptOodgAbnVk2K31jurN3Z1Rr+BOmrQfl03KnMMIEMglA3xavT+
C8Fkmcq8ri0f91D0ZRXd9xJ5fE21PpIjBsUtdKAhS4OGCRGMS93Oywc8oM5D0kdFYO715KNzSqFm
qT0r2W9lzgDEL4IFmI8gCig8H+kyupq+wlhdfaYQBcq+WzkJp5xGAPS9Y/LQBQTEPOdh/YvlrWk6
HfQiGFdeW2FCNP0AEBaNmm5ZFA4oHdXGlPBY09YSb5wGGzgDKEAfvk/Tx8W/75AnaRvVwSxzdjSe
INgiq4XihZDNG1kzlnTCsILkI3OB9ISIzfWJk+UpcXRxtk8f6R80xF/up7yYUm+ycIagizhMghZ3
3gV4miUqSi3M+vWQ0Z8Okt+B/o6eWM61iKe8De1vXOsuLVuaW0xJjubhxgr7b6yN8KS/PjjZEWKB
FMhHwEBo/ysp6U1pjowaeLGW8qkc57Cu61OWB7tMVQaXbd6tJSHasjRbxtwF7UwydE1kZG4T5gRK
LL5T6gr/U5kSAqC1+vlc1+AhadNfDf3Fuu++fXrPvCGQY+siOe8KG7dzaVDWHkaj23lUQ7AEANmq
TvbZqDgu5GMBaIy/iNHxK/p325Rr12As07xj9bHE5UWRmJa7wB8LwlB8q0l6G5529pfoBzBD5PY9
3S1AJP0xYV76MVnHdkw4fRIxv6VcZvVlVR16qnkSYg6oVKoUXIbgDmhu7L0T7ILj9RWXBTUQ1HGS
ci6IJwYat1nSYMnA9gFViQ6yRaS9K8jN5D/+vG5HFtC2doTl6KxizIsKdhiEBMCvquX08O8WQIqN
BEuA7CjC2uVq+MQJam8Gc1ZnxMDDLNbn67//1rcsXkC2BoQLXNBMGlR1Oa1CGfZWvzN3dR2hQJcc
vfXTlP1aq5sc5Xe67ibWRM2XARzNa9SW3xcahPkpT26gdZ6iT1UxcJmPgHgabaO47wHmJQx8WbSh
6318l+eDkVZ7nRO12Kts+VDNQgENJCM4a4UwN7XW7DEvwNlXLai6GsAVK/arrOCMm9cfE8IwSGLS
oNYS9A3T/JiYd0s+Re4cA6l/T3Kgzy2ihwZAj3P7NHR+2H4q6thZvENtFLGVfnSy265R4VpktyaO
aYFbAQWAx9alTy1Wwwo24psSr74z3U/p8tPI21uzsj50ln0DwRYVTJ2P8i8nA7yFv3t4r5kw0aW+
mgyEjuCLqB8Mo9033s+RZ6TprUufrzu0DH9mczA8dgtKeEDhX46uIWtdNybYs/w791Sd9aN/Z8XD
3rllRzN2HouI7txP2d1wv/4ATWFsh00EkXDAeobIjuneO+ihq+pRl9Xftx8l1t9njRpuUuCjiIlN
ZOdHXLsjFtjHTPcPxdLHA0go7fFuXuzIz7LHqp8f/MH/AqTv/vr8KD9FiFmojAykt3GEaPf0qEHN
lJ7I3vhCjuCdPOeH8Sb7dN0iX1xx8bHqaMhEVzvYkgWDNikac+Zn1ohu1nQKzfkLa0Ab/vG6GZlX
b80I5xaFp5taiimeGTQZo6ze4RAujohPg8KSrCpto7gBamnk7XBP4rFrkzswOptZuYca5tjanwKn
+xkkw61dOkO4Zk++HRfFrgKsgXRebHSu4myTBUY87fEQwYvOwKlwabwfNWq24Pg9F9aBrF7UDul+
rlWodNmOBTQbUAYAIZGiFGYzsRbLgfQfwKIFC9281YDGrNBMixaJhtn/pb2mKFVJDaJeC+JueAo6
zy6HBcjBMMwu5jS98W8ciORG3WOlSiNI525jRJg7w5wSEDXbQA2iVsNAQ9gG301fscNkpwpaDX+P
RPCONWUAYLtOdt6HiqV/o2YQt9L2p4U4Oja9VzT8p5ddGdOwuLUOeQOEmh0PZ/21f6we1lvjq7XP
b+wIr8UHsCEcjPl5yE6+Cnpi8QW59i3CyRboHR47Ab4lSOPkNv2ZRs5XBwrgMyrh5Y6crLOxx8FW
7adzOtzOB2CKigf7ln6bd/U9+Y/eDx+KfRHOzwHABvH1WCC91WwnigeLzQ5l6aqTNIE3IbztwAqL
eLBLwGq3W7KIIul9ar4Fw/+R9qW9cetI179IgHZRX7X1ajvyljhfhNwkFrVT+/Lr3yPfZ+Z205om
bl4MMAOMgVSTKhaLVXXOcQgc2p0PyWGS7sdfUO7uXHlvCR4FIsfm7iNLndVkWR27QIkqf0289EAF
ujxbEfaf1eKevV6tJLOOQoUKbu31d2bQ3Am287ZHowd3/e8nRl7JhoRPLft+7N7+VLe3B3iB63+7
1KOxMtYvhazyZ+Utruwxwfvv9qk3+NklW8oiJHj4+aZ5kovjaO4VImghinZo/fuFv0nm0o/5Oo4s
DUecUadVRKoRon36FFUiig7Ouk+5M2jgBYV6wq8M7D2ob9z+IluNbxCu/yeAIVZdL0bBtRcPBKa8
qLpX3XcM2r6lXnav+s/xaXxJauc3OBrVIPuinma8pnfZt+El3ysCzxDtKRdgUjnS9QwjIeeF3FWQ
c56pKDlf/fZ/hzAkD9cLXRQ5buoe14GOeetVm1157XboYD5Io2M9lLvb+ypyQy4QjFBT05ocF3d5
DqavvaCfsdm9ufhqfPFBM2nbxOtiul/zveROT9kuRyVqdlSXPeFxl+wbdj9Wd7MoVdiszV9a5sKD
SptqVmosrHKYZ+O/zungxHv1rT3Uh3Fn3wPKNkIwTuCn637d+Hofo+QXZ04fKKChEdx0ATcycaok
aA1n8Mr5XSNPtBc4i8gal5/U1iRJIHxOzo0H1Oa3YZ8dYldxqf//5ST8tMNEJX1K1DWQSF5NWZBp
uV+bgvticy1QDwEGCI0+wCiu/T63epuh8Ia14OqmR0yTaT6d3OLrfBLRpm275YUtzjkaWlIzTrFv
soRJlEl17EV1psnaDTbGZZoZIinflMqheREmvYVB6HxnQkyYmMXgdJloAHwzplz8Gu62IZNKu5ng
KrCSIXWXyXrUmSactl7/lU+eeWGF8xVLn8dIXj0zusu9JbD2cqCdyRnpRhIMgQjQvnkzXFjj7h4y
a5OJajFu/8QpgPk4WKPHrD9Jai+McNdPNWaKPcnrGS8Vf65f5kISeL7o03C3Tq8bXV3YsGCX34vx
VMmiiYvtZ9vFGrgLBSgkaow9LEjaa9rrfpQe5rSHiLWPWZJkPCp08CpIPhBUDG+fatGB4y6aKjdT
uV0donhPjsWO+cpJetFR+TnctvM/TtvHjOM6XsvHxCaZmsmOe0yjqhn4f8veMKGf3md94rKpKBWP
yNVs4EGXzaMD8ecxTBUCQeF6sRZIzVQa2/eqUia7qCxMoGG7BNehXWoiKrV1wZ9PyD+/kzshdECX
FwUTRKAo0Cfk4w1z/Fj9Mo2CHdlMjfGaXBVLABf6VAlWFtXUVjxRk0UuEDZONAfRWHuD9Fuw9ZuH
/sISF+jkIdFIPMeY1m5zNzUBm7HvUul5euyAZHzRIVBhIqJBbEtTnm6b3lwjRLYNHU91kKVyfm20
di6V2iqwrhZOkmqKMxDbNyPtiO8sytc3v9yFMc6VtUWuhn4CaoUmy/d5jLWDVU5re43Kbj0AKjVD
3ywgcyMqCG+eIejlQtsWbWwg8K8vLaifNgYtMCbcRX/ZqI4m48OsnuMxaOKHFNNEGEq5va2bK70w
uP6gi/wiNxQpogMMzu24A9sx5pXuJ7DhUAVdJMPw6PIn7xQCmAWGfYCz4r/jUkP5A6M9OLzvqVYe
Z6V9NRXggW4va/O6gK6qpoPjeCXlu15WlUBYj0xteg4saOpNO2hepboTi3gMNzuxGNZYPxiQ9hD5
vrYzYl5wtiqspgSjwQLkovqzSnazlDtK8wXAVKeqMUormkn9wMnxkQXSM/APAF/RguOWl/S0GiCY
siL4pvO8N490N97F38dHa3T6sAjNA27hv1TJWU5sX4ZzUKH82z/VvdO8oPS+E72mNkPy5Q/i9qEb
U5LF6w+aXSuw/cy33GrXnNIge9GD7EF7S8NFeNWt8fPWLnCXKc1nbYwiGJWx/vTLX5HX+NJucZXz
z+KL6GGz5VGXK+TijwWmG6uRPra8DH4DXOaUgtzgQyDw1nq4w7+0upEkI0yg2XRvQ6X53m7dMyqt
J/VL81jvmdvvEYQC5Ri9xYfm2B/kr7ePzbY/XzgWHw4KKMeaPX5CfjA8fZcdO6dxIrx6RU+ArXB+
sZ38Qy5q1KjIbBgCjU/ThYwdwYMNwbDX2wta/e7Gln5kSxfhDYOFC9TOEN5QKJcdzRWNm2oCt+Bz
kSFeGmKWWIf2UO97f0ITJnLZm350rPvqXj/E/nKcdtqT4Y7B7CW7vHR0v/wrDZb72Zvu6Xn8iv89
qk72F92XriHIDLYwXhgy/G+k4GEu6ZJS1DDx++bytcHg353uMuokOSSX3OS+9GTrr8g+mXim3N74
zTz00jAXoqY2NgvwaCFEuaMrO6lrnXSHeMVBdYjg4GzdYZemuOCzlENdFGz1Jd84NF9QFvDXiqdg
QSJX4qJNrHcatJZg5W769SU7TE7rDP4An/oNmY2D/VAIah2iVXEBZ1C6uU4o7HWe6dtB763rEqlC
iI4hF3J0mZHEHmBkURzpfjlmsHF73z4GWm8dQS6kGOD9wTKARgZ8E1VpBrp0tzqqvukZr+xBPvSD
O9yV99NrhfDd//oBCZjbv2BzjQB1rm1ZjC1pnHvYSyKn1oI72m5CYGLt6XurvVi9oNywGQhAnwJ4
IZiAwaRynQnMADrFUdFh8Nxw6rJ3Ic+W2t4Su0JF6e3LFgABSL8i48BI5bWpCkySZaEBJaA9WWC/
J8EI5AtJXidFCQaiumjBOj2wF1avg2cI4Lk7o/hRgIHk9r5uNlkB2AOEFAA6SLWuj4WL4JrKhTml
EZasdO7IfsVmUDN/gKrEt0T+3oBKyVwmx04LvzDOi3YUzUVu0ShAyBIz3MjxlJVb6to+gntOjGmd
Tme622c/9XlydHBFluN+fC/SYIQU6XhQpuNk/xIsffNrg3tsBQ5i1pRnfJYJNXRGMUWuksFBXJ2q
twSUCcAiSfq+6uWgK3ZoQq/gfqSNbqeHclc7y8ycVR1FpKW1HqFPRwwTB9AFA0M0KDauN6KEgprB
8hWLlpXEyRvpqa/sp6SDnp4NSKWf5il1Rkx/g2IrexNsxVZ9GYDp/xrnnoRZx5pGYkBcQIjMo43y
rGtvQ3wGxuWwpPp924MxrYj96p3+gYqAjllfdHAxb26AZPN62ahyxFXXA5cD6ZeO3CXkPLKHScTW
uLW5K4CFrFy4OHGcl5dV0pidaeN2aYZTnJRHlfVYWf1cUxWvpe7H0ijfQBD38/a+bnnYpVmueBC1
C/BFC8yquw7AhJgVvhSVTmTVd93cC47y1t2GoX14sg26WkzTX+/kbGoS6xbsZMbeISZYAW8rVI7a
us/AewSq1fXMqvzTttVzSiUUvOAZsVtpb8j69Kr0stSfe7ADVYog7G9W7EHIjl476r9ACnBhUlbr
6m9oDjPQGW1/xDXI/+vWKZvQ3ve5FDCKLhNQ07KNDkKyr1UUbrvFJ4z8YFQWNM82txhIGvC+QPUA
kyLXW9xLcq5LFN9T0xtHUl4yDYhcS4S/20y7wOZjoBAEYkS8r6/NjHPK1IxIOBPgddEOfZc5cmYB
Fzl4Q+qDdEVnblK66P3cdtfN5YFvZWXTxZz6R6/64i6IlsUoaJdCBW8gq96CMZneGAncdHN1YJww
ICkEP8LE/fXqVKVTc431mE5PkupESllzM62lvh3J6aFb1C5A/VM7zQz/V0XetLE2Tz2q7YJa1BbJ
B6avMGm7ju5hTp7LBbtmSG0JFcfzMH+JM69JRgeqiY5m7C3LrxbfkLQ7CEXVS+vFJX1T9X2k30ko
QlSrlnUX7//95l/+HM7ToY1tNADcYNTUSvc9SF+W6aWURL61FQjBgwkIOygjgJnnAj2khMtxrHHL
FK3lW/b3eWpOlQVwsAkSxza+t9Taqas/YFFe2Tf/a5ULv3lu5nMG2c4zs94LdXAJMEzLqzVpTlEs
0DEWUZ9vZYtAQKIxDMpuXCvcXTq3E4E0hYVsMXsBBXGQpkdSU7cn4R98M4hFABn/AZTlvlmctFFM
ZsQDSX+nErRWkPd2qqjfsHUsbcxvAR4PbSmkv9cHJkZvuRs6gBGqNr8z+t9oUgXx8vv2Urauqksj
64+4OPtzXdR1v2JGdKt15/pdhjKR/mUpvHJsBBFg/b18pnNpijt4klTUUzthPYj4HgGBZyUwsOnk
FxvGfZayzZJeTqGXbY7aV4VCz9nEq77RD1bOXCrrBxJNfpIKA/em213Y5W7gaKrsKQZq9By30a8O
wxVGMv1aTOm0yLgobn+vzZtxpSQHShvqOID7XH+wBixtVkxgbOh8nYby5Mrml7IIyPBQxj+Ikjpk
ubMs6jDzLpa/xehSVnhITLmo3L3pnhc/hAspBrPVUV+xMixJXUV9Uc3MYcvu9nI3fQayPBbm/VUD
Refr1doZwJXxAPdU4tgD0Q7asKbAaza/3oUJ7uvNyzCb0gCviVt635iGZzVtQC39VwHux9ur2dyy
C1PcFRjVlT4O62qS9l1mAFLT30xElbNtAwTKEM8C3yHPbGowsE7IK4yzkUuXSL8bUjlIGv5kIf8Y
4b59bncF63HezmQJJSSc8nA3zCKOnM3QBLDSf1bC3R5jMc96YsMIJtRdqKIy6VnB6P8yYPw/fvuT
BaGlh1chGgI8D4kqDzOQRHCCRgH2tXlhlu40f4IqWTU5kEBDKQIp3rUzD0kxDnTNgKw2Gh3QYg17
MlVR0LHMFjj1phdcmFr/fhHWxypXlKjC3kXla9kX3liHM6g/bm/a5uEEMAGIOROwTR7uNTdJ2Ufa
CLhXY72MC/ktCVk0N+slNmSEQQW4SnR9DHleLKSwqKkX7Yzc1IpBAUiHe0UvTmWRe3HXB0nRfelw
TEGGdycxdIkH3yzjBEgX6mVafB7NSFAq2tzYi9/DfUMQOgwRNQGoadfJkDGEJA3LXm/v60ZEWlm9
URDQwZsPytLrj9eUA9bZw0/Kvt9PMkl3EDGsPJpbszPKIpXCrTLzlTkuADLVroZ4wmcs2BiUDcLF
+JeyyC9EHr+WoJSh+SGzDlKrOVpR+BBu9BLRJN1qgksNMLQJJh6wK5kARWnXK5amSDfLeUCqkzaO
3BaOIfVuIy8+VbMvKfixRCMpG657ZZD7jJlJ5RmqNcCvQqkd2BZr9vWoJILbayOCXVnhTmGrFble
6ljWXL2T1GOBYuxGNN6ZaGx8q5x2ZWl1qYtjgjyjTzvMwIDP+pGaIUtGr9fuln1mfIEumKdDP7S5
60Aj0A+CIPA/TIPEbH0aQ1aa+3ZQ4yFy1gJWmphPGW7nmIE0CA/XXaYkPgGpMmTv78j8OJnqPTJA
gfmN84iFm6DMAuDZ/sTNVU4p2BEywM+WofCy7pgBdSrlj7cP5EZiiaFc8FuAqQDyLBp3bxOWgxOC
YGgleQcXexNG+ik3KIj1ziqyvcL8fdvcByr803H4x57O5XgQRo4beQBLIy2CsTzQc7anYZ97/fgg
N5mTU8dCIVx9nsF7poBCCfQh7S/FeIhytzS8GPRrk688SDtFRNcl/GXcxQ9gs9JlBnYCQ74Yk9Pe
oh2usmRPz/YTewbDUr8joUJ9yXbk2s2ZY1BfBltrVLj70onf7MPtrdo8x2B1BisI8Cawfu33E9D1
9mDNeGHq7+gPVETwKTZPMPhv0KhXMXKscydYSns4H10LX5NyouNrAllsjCQa72BKEPSMtpB4ALIg
qQcGCXRVPMAEHMsokSR4LSsK8IRfx8JT9Fe1W5y5gcRV8Qwiey/XrTOpYncwg3J6oEZQN2guIf03
ze+ToOq1/YMM3QLpHUpfmMS43twEP5RONn4QtBbsYWcyjFiDEDGI1e99+Zjnp9qyMcnjQVou0V9U
j/XfF31PISBvF6Lpcu6GQLsEj+D1JWzpMi5GnvoFLWe1wB+rECSpxU6LlDKQRmlyDStN3akAqdfQ
WA2gGihZ33YxvnD1YRrlBMuwNYwuWTwREl1srS10uQoxlOroijso6o4shzEJJ2OXNalXy6C9rFgA
ogyBe3OZwN+mUSaHb0NdxLC4TIBJZCE1KBbCkZCnyn4FRjG0qqCVBPk8F+A+2eFSANXo1cqIaBVG
daBlL+WDrANPFX0jRelMw1+ddb69p9yx+mSPC6hdXeuxksNek3wnwyPIUxz7mIFThzW94PNxF8Tf
ppBUqHgPQeear90CuB8nHbHLsFYT/TAQ8L7HhNyD/qMTxIrNTcQgH9qIuI8+ofijoajyssCi9OFc
TYZLkMeYKb3r+p9gZfha5Q+tLcCk8Xirj9WBkRtKEphWgqYB9+EkBD9FG6QyTKmnsEOcUIc0PxL9
eVR7x8hRNS72wCgHkCWqIuqNvT+DI3CPexwh5hj34I50oEXb2edZzo/mMDk9tKll8nz7e/Np/P/9
TuAygBE3cU9zcbqjxAY1RFGFzIvB4uGqplM1rpw5sS8f2m8tc6reocj9nP7ptumtr4Knw38tq9dB
zOoxRr7SAIZlR0BOawYtyB6XNttBUilgUQ1NKvqKm19worY8HNrY6KyunBsgBLo2C3E6BazArApR
qvFaUHPT8j2xf5r5c2oLspOt0Hhhih+Wh4BJ2TQq9tZotCbQh8TVlXy8IyYgKdqiNr5l5MPRBrGJ
4GgJ1sgXlSe71UoJgmsh5P+eFrN3ZuXMauZNybc8+/UHn3FlwcILAZQJPGg6g7TNYg5NFYLf32H1
Q7WES/aAt5Gv2sn9mN/JjeBsfTCxXGRhHz5r4tshtQABHurJ159wZW9hZp+xcFEsADG7el9C49BR
tFp3czrNJ3swgNTLFmlHp2Xad5RWQW0DqT9qSxlMZvJrGe3ea2u92xPovu7LCGJQagkuSoUW3u0N
2roqVnFhzAspYKTm0/DBliOVTLiloskeXOg9FgeSQ5YzBrh/5barg9v2tuKqpYDnCncx1KF07kQP
ZAGXiFSwcAoOkysYNOUfFR97f/mvc6cWkr+TlkT41zXSBsr4lBVvuXGIogcjfUjVXV/9GEjsMbIj
orFQPsX92zTwyyDKAe2CzBfQejCWzzhELOwWBr24k2Wzp06zXT0hfq32T332i2meickEzPXlvWN/
WfLTbGCKA8oEST+eqLyTsn2Xj8chz92IHePUKSRRdezTqQdZLgilMEQKnuC1o3btnfKSmhVNJRaa
1nxS2tqd8Moazq0s7+sqfUbuJppU2P4oK20RSGrW2RXusqH61II3acLODPGwo83UHUrUmdxULRc3
bdT8SHHvOZM61fvOMOZ7NZ2LXaL1tteXkSrykdXD+PMJZUJLMTElh6jAvXn1vlb6TGIs1Fns18q+
rZ0oPpTWsZTc5VGzQJoQ3Wc/b7s9PxL1t3ugqQVOUVSjNF6kaDDGuVtIyUI5UQIJxfVWOca/chDR
kNj43QDE4NYT+Z6VAXhXHInEd+M4YsRmwe0vfYsX6ut1vGfSO57M4LZsBTF567rDOwjof1DkoF3N
HRwGFKwpTz0LRzZ+R6ZquyjKzY5Oiu6gstF2tIzk+2iQdF/qq1YQFPgnw8fu4EtA9gaDNSs52LVX
dqQvJVLWLFSyBTi+eipGMDORuH+z6Vic0dONYldrltKTcJ72w1ADXGEPWnsAGbrKnNmK2UnW2/gr
K/tRAqfjNJwnVWejC344w5dAuP92+4tu5vfrJDb8GrNQmDi4/s1AvsQ1wzRdqKvzsTKmgwnN17RE
2jvGfvGkmScauUujuyP0qAS215c878PIEEAsvmpcI5he21byuK2yScV+fctOuUPwH81NkQYJ7Gyd
lUs7XDoCnFpmpTbsmMU75s4oMd1IeszZG0Zg3XntwpuOQtp7W5Tpf74mcEpQwoda80o6xSO/67yt
S6vAcUnAjTxGjkV/FSKppY3s8toIdxeRKbcnI8NtoYbxUjnDcxvdQSjaGRrmpem+yF+0N8s4Z8g3
87T0KiShInaINRm4/pB4Ha7Tg0jGQYDGf8jaqCO9m0dch3oeaMXwPMgioTd+wBuHCy/BlUEEzA1Q
KDA4R0UdXh6mpqhDZYZwGdQsc9DTgZPykBRnGjNXsma3hrS8CCL5Oc+7trv+/bK4SLORKRrsAp6+
NMdJ2en2DgTHmmjac8tZMGYDdg0F/HGfoPYF6BilMi5rVNVtvJ1oH7mSgRZq0cUi7bHtzVxpShCs
QIfHdxabSeoj1WzqsIybc9Lpd6xrHQuoeCnGdVWzPUulkxpVh9QuRYWV9W7mncXAzYUMB29SkOtf
b2gdLVBhSeY6tGOz8yaGRMOSKTDIBUonk+5O9Vx5rZlaTtq2uV9OSeOSeYTEXNsw0MVUohrHp2Ri
9SyEn7XfgCIaX+KIEO2MeZTrUCvVJ8lMH80BLFrU+lkZ86HUy701iSLfehHxe4CixqqxbeC9zGfX
hjpEeTdWdTi0qW/RwrVNdpjHkBahWs/eiNTalDM3UzsApsHHHC2CmLjlbGAtWxlkkNOAQeb6I0AQ
pkhmeYCzmT0yy9xce8vIHMB3Klrr+j0/rfXCFHcrpl1RLZmCHtxQLd9B2YpU4T0e8/eYKcfFaqC9
PKJ6bruyPjtTVpzaQXfBcIf8Rd7NIKVGy+X2fbC1dgx8gbUZzykZgeV67RA0t+vMyuuwWWLIiMoO
OJsHiJretrK1bMxXySv/NBibCXe5ZXqeTT1qPaEZDbuWqU4r27+ZzvZK3fq3TW0dZ9To/gZlolzL
T5fptawlU48pcRJJfi0zVx5ImHeNM0FPCz1j6bmqpBbiHdmdSYPbxjdiPzh5wBi6CqUiGeXK9aZF
Kmux19HE6Lkyf86WIEPZ2EfUeFAaVsEyhyt0/ftF/GWqXE7y0jehnHuSmgOgfqfmdwA23l7GhlNc
meHCPNX7nhkKzDTfNE//0j//wT+P/onxUYrTeLhd085av/QQw8g1gEpyf4ZOUyT9e8de1XSQSqmA
5mFA63qrWgDAc1ZPTbjojVvTxE37fDeq+9tL2fjgV1a4bAr0k0SZe1hpwM727w/N5b/NE7HJydCZ
+BJNmBZDYOWSK2vvtfqD0D9xqn92iteaIbGc1PkIO0uHuagY116Def8dy0Rxlu8vr2kLVgQRZR2F
G0wKrLt54b5S2adjWqk4mnniLBQV5iF2BgCBJRDKOfb80KpOXu6QfdKXYRD1YDcPz4V1LvbmSZmN
dQ7r8zK5moYSoznj3SV5MbRcb7vF+tm5ML+qmWJOASvGxcKZKic9wcxF3sL5TBAq1FK+k9Rh2uux
itxXAVVpgsm3DLXBO1OJRWCdreOLeXrQ74JVEDJZfJSA3qRSqWUbzs1jNDdBPqQALVT+7TVuFAFA
Xgw0DmitoaqBOV7uaypl26sma8MamuCoxA1BpakBptVOhtoHdiydWbGfaX2woUiTLlpgGJLg+PEz
cB8ehRoXemWQ50ZbhDvlqlVKnUIa0IkZ8Rsjd0a0EmrL/gymLpOcehRcWCl5xqg6qtWWTq3UZ2nR
9rSJg8F4VsC/fXtXNvceDxykrCY6d4R7gNDIJNUU922YoC0KFbYBLVoh+npd1Sf3ujDC7XxczQX0
B4Y2lKRlN5u1Q+Z7rflB4kdFPigicQzRkrgUgdBUhchBB2sdc7Sxz4CbDwu1Eh2arfO5vg3/s3Vc
dNByWUqRi7dhFzl6+WwTqEeo30phGNp4xOANCp5aE7WidQD82m8Hmem0n2WsB1M0Xa/6MT3UEShl
Fd2fDcEp2V7UP8Y4B02KyiiMGMZK892232LyYiwhpmf+IOBgKsECB+IH8oNzu6mukDRMcxfWeB/J
5c/B+DbEULGednL2rManrPp2288/n359HV9DocRGgQd9YS7VSbRhUY1YqpC1A5cxll5rYHAceOcF
t4e8hzJGX++MLHGMBorqgor8J5dcjYMxFWQxmHJVeZY3MsdxklWobeX2CxK6tOmcFiKdt5f4KYij
rgpYAFBpSCdB2s99uribDRlseChY9I/TIT70JmgIdop00vLBo7pAnmhjSVfWuEwCAh99NssGC2cl
VKLeHfXEqdVFEJ4+F0jWRa0UzQSDMkTmL3urtKM0sgkLawl1GGs0MZth1ccpliUoRtb6l1FLdZ/i
obkvSFntVAnT7AR8cUEzdyfclrWDEs8IwV9022/v9+YOQH5nffUT5O/cfts1aTHtFrGQunr2q1me
zX8pOAZtOSz+wgK3x3Oegqs+hYU2wXuSlYGGeJkbztjKd5qIfeRzNfHaGp+/9bURN30LazmALFEm
H/S0c1NiAyVF7kBN4jSoLnbA9CE61Jayv72bnzJTzjoXEaRuXPJusVhoSBE4q8wlchOLicYF1m9y
dRPBigZt5hU5iMEvXjiJIMkhQ4Q1kmK3sH1q7AeAksYDdGsTEV/G5obimgc8aQUBo5h4Hbg1Bgok
e8rq0JjNY0PrX1bzVI+Kj3HPFEKnluK389itPTe/TtXw9n5+fleuS8VADm4NENdgDOPaejkDbAIm
eLjnKjlcveu97lV690yNKoT2yt1g6Ufolzyayyg4GJ/ukA/L6DLgoY6pF5PL50ASXShGFtdhV8u7
rmwD6UfT2rtBTQ6317h1AjFUA64VjGBiMJkzlNJmhioACiFyjmGiuCaaS0mDMQl0EwVr+uyeOFs2
Ll+0T8B+wncnhn4edFIpdZgvAFNNVm0iq+h0wYJEVrTrb1aVkjF0iVmHk+qBQaauvdsbtuGSKE+i
54bZZwQstFmuDUgANuF+s+qQPrd96lQg9xvzXWI/zFRzzSiY6oAU97n0etsuTx2DSAa7cESIla3Q
bR4gCAlAK1XaBG+ZBiLgjCLtNSYkTInMpF2WK6BngMqXmwM37I0AGwP5Qea9TSAGLA/5i6VjN1Du
ZI+aTie/KeXnpUyb/cz6ygVooAgKqQ7qSEZWpMuPlR7Tu2y2NAhp5aM/RvoQJA0B2YAlNQLHWGPw
dURZV4YDjoYrRv55BYxlqQei5RQlFK3x04b6qqIFVecNX1D/67sxc9R+8G9v5+codmnT5KH4WjTa
cPy4CaWvxUv23X7tnQJvBkE+seWMaMjbJmb+0Tjl3ypGPSwZKRjKHottuQO0mtxukWtBM/SjYsdv
ICTswDy4ansDL8a5JOa2c8xiNKFqnGKaf52g3SWVjoJpGxSPdh1LPRNDmSmo9+S4cuN4uadg9elG
CewDPzWzgK8oTlGB+73cZ/kDA/jeRiOb1d9u7/rnsIauNTIQpI8Yi8Fg//UPzbSCobVfNGGRPS3T
KX6JtC+5Ipil/JTsr4KPyEjQJsGhMU3OCMYVpsUmqMip0Ze6W85pMrg91Y+oOHu2iNz4c/yEsXVo
HWgs6AfwkxBlZJfLlDUoz1kYbMrqvZxGSK0igSNtmkGbEKjotfnD8xDTDgdUbeUm7BLSektFIDQK
lOtenfNsd/sbbW7fqj9s4VMRFOyuv1GjRQ3aEEoTtuoxsWVvKvcUBK15/DXuBHiKrYOPjg9GeFeN
eMJXBZOkruN0tpqwTyQgrhw5xst5dOQGox2rUpvMvsp1L1jfplEDaG7oN+K/7fXvFxWpaqliC2T8
TWj1uyiaTukAyi2Ai1wNOUwBuuD+1+0N/TxLBIfEzfp/FjEnf21RBimdKpUmHHKnHHLJ+6q5ejAH
mQe5aq9yIQLjdH4DriHiRoIwt/UxL01zKWE0mh0rFgkfU4qkJ8Ouf1Cl81hTF44FrSu/iDUR2fSm
SSCCPsaZURPnVttYdVyma32mzg66nyOEd8phqHZxIQKibeRnyA1XkVKcQDwJef8BQExB2xBFkXn6
niDZdlM9UDPTU4wDJRiPlh/txhBcVjx5ysc9bK7QHAhdoRj18aMu/AcSR6h4JrQNDcWrvtcv1cv8
kj5EB8m1/Mmdv6mSZw2H2y60dY9geBKvXyTeEIXk9pRQtdOUqm5DTF1g2KbzlP7ttoWtU2EiZNrY
TUxZf7z9L1ZVNHFV6srUItV9TMvvUwt9KNmxKYRewb4bl65ORUWmrSsYEHxMMcEqMpvVkS5Mgtgz
1edGQ90sNo7Wt7Tqd8pjbjeeFWuveNcJPpzI3Pr3C3NtnPdWFOltKIN1Oho1MEhAkS8rfzTanaKe
GOoYt7d00yBaqxCPhxDGp4mpPK4sqWdKi66UsQQxyQiyNgJoDEiA9vY4dX7VoS8WZfEiiKtbtwUy
xLVQg94qHtfXSyWNlramaWJn235NSGkbxFZaeFXc5d7tRW55pgU2IxWYZLRy+Um0gdbT3ERJF+Zz
VfvdqJaOFePWuG1lK2+4tLL+iotvpymLksl22oVmHoFD1AD4+TGOX/RaRJWwaQiX7DrbtdJDrn+/
MGR2g2F3Ud+FjVy7EGzxtOElUb52EJq9vaKNfVPRDgG0GWkhnnjcLZQwu8k6iw6hWqSLL2d9eW9F
cfavi2Yakiy81sG7sU4jr45ysZwhj0YaD3kXIs6/YAYoXGgSyAYVXKkb/oaiHGZPUWhBB4THihR5
aTcas7pwSEoHbXUHu6YpIrDZxsWCGWCw+YC7A87AI04HWY9mOyn6kJpUdaW+TF02tu8DxiuDQqPd
mY1mKwgamytbBZQtbB8YH7gYlaWFqtQShc3kr44+aMW9lLze9oQNl8Mlgt4u+CRWmXLOxMzMdiIY
eAtbGY2wfDRUT2KYH+0zy/BajKT9e8/TMOSB5z66sYDwcz6B8SF7VqnRQ8XJroO5M5eDzCrVv72q
rY+FM7SKDQIcjKbYtecZ0P6JIDnZo0oEXs+oOVeL4WqPSs0CkpePt41tvck1DDSAvc3CdCboxK+t
tWyQaZwYY2gXCrgZuwLS8lKjhtOMCQoJ71mX1vbom7WkBrmcqMdBNYegySpVEKi2lo2eFBDLeIfh
SHDLrvUUfW4rHUOlM8sdtBBB3KpMntmVz6BIeJjh3gIP3ajKY8QOtTgbDW88e3i2JLtlbWvr0hCC
2Rh3JyZUvUZJksBmGTRkBlbd910pe8gtpHvcN+xUxDZKFjJAI7IFcu3bn2Ijj7j6NdzVI6GYNA2j
OYRTJzNPq6LOH0xbcmlhA4CaacmxZxpzjb7tjwqQxwLzG3cupoqQTGDeGmAtvoBv111SFUUxhiUu
Wqsh3632ritMd+nel3rZ00jWBF98c8EXFrlAzuzKjgkmXcOctrtqeKtfsqjZr0gqzZms80y/3t7g
jXCBsisYw1EVRKeXv3ArIA7KyKymcLF/KGU42hNIw1H7ESnvbkQ+HTW6/8fZl/ZGjsPa/iID3pev
8lKuNXFSSSf5YiTdHe/77l//joP77lSpfEuYmQXTgwChJZEURR4eGgCGLc3odOFe0jAnqo6N0Yvn
yumqlKAqt8uFt/urWZGCUi6GnwJSjtwg/a7VgburU3GYvFrRDhIXjFYgpzbXNgbDH63ct7htZaRI
QIKEaUPUxQ5SjAB0o93sxT0IHqdCa6yqFCtG4HUrZQE6oBMZHkDCfyk/VKnDVBmd0ntcVACgWROZ
BSe73TBIQC0Tj1e0piCXce3pKkwVCUBXCe6BCQT4FTojNC02uYpnGNKKS10EIQYCrACxHc1XkSAs
7YWxHTx+OnJSeKiK4qTO8dNS6BPB9fKeh3/94Xc3RIz76VbBUaVa3iFo+UTijH4/ylEqyn7ajN74
OzLsHqinzhJYQzDWtnHpJgJ/xRK2KJTVSkEfClUtjl49VVamtyQFsUirf9/X7hV1ABAfRRJwl0qo
wVGH1fScqAVBM3t88FCWMenmr/sCbt0dVAGdKvjtIL3HM+NaGwS0idfgvOC9WisGu4x5GTkUdXwE
us/KM763ShHYgHFQMsaNuyZYR1YTr7eFN4VmENUaRUgT8LMC6q+TenJAoq7O4LnlzagHNiFtGea7
cl6o/+Kk0A+LTCfdARbpfjJgpM7sVWNH+MFVk56M0+b+bt5e3khGAQ6KRl+8teFhr3czQYoKPiGb
vWJys+YrlGQz4R+WlL5SMEStKDl4KbESJA6h5HTr+lTm4yCBgwKdGrozpv3TPIB2r1U2Gjdv769q
RQllA1SrAO0gty7L0vWqkA+u9Yjvea/PUsPUOj606roqGf5i5YB+WBIgCVEYfMa1FF9LMY0SM1i8
IBvMPPXmoDI1FuvUos7Xee4FAQ+CHui8qqGWfS0kiWqu9TmJ96rMnuYHLtHNKEjNUN5IUm+2mW+L
/Of93Vs5KAUoehjvgntCZudaJLDgfpIoHO91oxI6cZMlJhcPM0nUatsmBs84rBUVREkVFAAaEAhw
v+K1OF+oZLlSK8HLTrWSm5WmOb4AvkQOadjJub+0NVkYRY/pv8tzQKRBMUUnGiXGvggeMvFRNFrN
GJlREj6U4n54vi/q53fRJ6ciQw54OfhzUNe8Xpc0CV1cp43olZy88cdjyAV2OtRErdNNyX9NDQkw
AFHmBEfOi2Pa+zYf5vY8lNsuFE5l0Du8b/y6/1ErPgwtUv/7TTTRRqegeRaT20QvKSN7jqzRdzh1
18qbTH/p5JZhICvJyiW9huwakoY4XbpHcwz1GWXdhPc41U2DjPjSOapTa6ocLTsl3AuKvOjUZJzx
ivHjehAw43lhEED0c73vUVHLQ6vlgtdmE5iEtX5Ey6wvMbzZiiZdSVmM6CLNoGVyr81NLHjLugoF
nVsCpizUGNMtYqBMzIDNrElDQh37KOLlA2qIa2kYpSuHSdULXiNkpC5N0T+iLXhsraxhaMiK8S/v
qmUoEyZwK3T6RFSSkvcDWfCiWrOVuE9IWMU96WRAWPOUlc5e0UekTkR4G2MBe9OlpEoZ8kGZfMEz
hsby1eA05GasnIX+Q+CCIzd499V/5eGI+BE9RcqCrkDimNrHASPu0zwFakJEQq3qz3PxLeWtmQvT
VlHsseAc3f/qQItmJMah91ksTCtlkSV+RSIXly0iZvrKiLU2VfWggv1lf6Y4+DVh1m2V8VuuVXel
JpEJMKSkljaInJxY4D8bDPIJ1H5bFZ6mcS+REx7KJ3Sc39+W2x5PuF3sCVhqlxm5OP9r9erSPqsq
DcmDoq0tKYVM+bEGr83gpPp7HIc2Uv86ClXJ384gAVonasC005e+nEnD/40G+RCjx8w3WB+25kDw
YQD5AlpoCLjRrz8sBbIhAGQM+4XHy1QHJA4mK45KommdHXQ6meTcrNNp03Qyw8BX3AiYJQG/QcyH
sJyGuArVkMqtPohe1ylgfeH6Csh0jlXlWDM3NGRh8jvIXpYm0usFDoMi5IAviZ5cvY5DbCnNjFSG
5Ph5yQgnV1zI8vsBSwc27NYXN3EkhbqUiV4+S1aSBRbQLoSXMBW72SAi+0/SECXrIkJmPHav15UF
owS+ExxcFuuaUyl41gRohXXGEUMHR6QsvrkhzP99JKGpeHosJLU/yPtroRijlISaNokAVbwquWYB
Hm133HFou42as7I+KxhD3C54kiJ8Xt47NBWJXIddG/iq6AncbBfTDB/JETWQ7JmfLBApmL5aump0
CqJPo4x33fCnFNxBAgXJNDAMeE2LkBgBNQHe32g+pXZ7VAehmsVZ9PRpazS/hv4ca89T7t53E6tS
ZKQsNDTh48ahvITQT4Y2tpzo8XH6KPTjUaqzYqPoLaayqCywyi3mHT4J7LmA+qJetgQQ14c5qXFW
JPBYXtYg811vjMQBItxRmmQ38s1zED3l/e/SsFsMjpgN3hbT1kozDX/GzMqK1am5snZYqLy8Jnik
BiTKEc35MOZxnspekW2McQBJEDj7xrMcMezmtnkEOLFLQdQmB74i5emYQJC85wYgVEDZPXVciz7J
g5Qnz5P+BF6TWtjmomED/PiaNRyDrGgJkKjAFa3TCDRwL4MEin54xlo/l6BTkL059wOM4C56149r
3ixktBPcV6kVJ3spigbHCHUS8VU8yl5W8AduTM9Jwcr9r53c0psCvB/gm3h3XutRJFdTmUUyhlrk
rfLUiCjxZkPBbcdxGhyZXQVYk4cjRCYJr0L0l1LywNTJKQOsx+un3K4VDMTRXkpFBn0no9C1tneX
gpYPuYhAhY5PYvgD7F0Fhpg8IsO/pP1GVgA9ssvQNiSnYIZ0x6jeYQrHKDaKh2JQFT4aGmDTDODS
mplfyaC2a5qaUuOzWoGA0Z5AW91sMR58L/iNM/HbUgSWeC5PBrgAx0dD6Xdd/VB2LwOPIYP/xcYv
l0ttKD/pYKwFegI3ZGoXYmMumxoZpW2wbv01C1vQFAjkZWSw6JT9pDQT3ozY2DQFF1gOIqgXMWbk
ZddiXSSyEdWhUr1wU1Auy1CrCgQAmuJh0k+akkRoEGeWClKbWo2xqj7oYkWhf+rlTAOrIlC2ko+W
lKLTyoMuh6w2gzWzWNjj0RkL9lxA6a61VcHI0iLvfcUbu03e7fvmoLwwFZYlhLoHwVznTxVmzniF
KBNt3vvhY+rH5n87v4vFUCmLqAPGju8NxauTkmTxhyxhOAdrZNCqklwIoS5AZNKyKKmxY2q2EUc3
Cp/6hPGsXHMhl4ey/PzChRRdkAdhjXVgrxr596D/645oeBCcuIKOaBCNYP7ttQDfAMSGN2rVC43f
tTADDvo+Sx1erd/375GVg0ch5ce9G8KSeKbkgCyrj+QcckJQVzV5Xtia4dd2kUTVEa1jrHWtJXeW
bClqUWj1BJKP0gCtbNo65iPVG/h3sUmIrJ20YZ83+SkNA1MVKjOZ1MdI3cQqyRTN1dtt/yIn4Euy
cxbL+urikV9aohN+4dm+XnwnF3Ocg/PN8/F6y4onrvbB6X4yJlavx4q6GPyFIMq8urrTSwA8oC7g
9EXlldTFvw89oChI2iwEHIhoKZ1PUMDnZ385R3EkZYy0OjBnPiORv7pfF0IorVcWPGkYVKpXi4dJ
O2jZHtQpw7/uLpcVqCJe1Mh+AZVEF5NytW91v+zUxXxRpiewX0zAIff1fq1kBRAAXiGgC4ezp9s1
+rINlQm5Dq9K4+kwKP4Lh7qm1VcAe2lpzh8D0QDNIF5L5VbodX2TzAkPxKmeJM79T1lxV3hXioCr
4KpZgKbXWigBrTsVfap5gvGiKTORMGGNWShbFYJkOCCQ/EJgtPz8wmFN0TAOldZqSLlvwfckiXu/
eby/jjXtQMPB/4qg19EFZSIUEGFgevsYCp9d+dal6H0RGBB2lqDlwX6xllAIRzTTVJon1e9JqFtz
/xJ0Xt+xysAsOXQcwPno6ug6yGm286A8Z8F0KqPob88zAlLW4VDOXskx7qb2Cw0aj9ZWzJwMdRKG
3/ePhyGEjiOiYUh9oSg1L+ZRakb7cY/57azZTcuWXL+AkPtEARgPIJRwoM7XR6N1rY9JPgbSkphf
Z8PviaaaTJJdFxjhE6FrI4yC0A31lpUPvV3dwh6CthcQZCF0p/ODs9SmnVHkklcjGR/GDxrqzsP4
en8L11aHVlbMQMQjBWSdlJOV4lHSfLmWPH341ICPG1CJiA6Jv20Huy9YOMbbvBOeirghQRCggaOC
LrnwTV31mjhKHmqnaL6MI1vs0saWI80qlWE/tz0jqLnVdwiEv8U/y1uaZuk0xrFGuUqQvGG0486r
0eqRp7vAiMz723h7Gy5yUEwCKgG5O5myKykAo2+BuqBXAwBl4sEMKrNAYEH311fzjxTKqEBsr6CZ
Q5TAE9QTpdksZYYxABXWxHBHa6qHKjBq9gs30s22pU1WxTFoxzyZ480M7LRRoRBfZUhZX84/Uqi4
KRirSskwg8DDjERnSE611BN1GUGiMp4/rOVQSs6FyHAU4HTwoH0E7N1h9aprH/9eA8CRvlgq6sxY
1LWbmKc5UloJhtQgYbOPs6h/WDiAGHq2Zq7IW4D/AUkFhAhU1FUY3ZCKcyt7nfGsBw8KemqfMENu
U4r9c8BJFYnEcdzeX9ma0QJWuLzU4IswQu16ZVJVdnGP6SQemHZtvf4L7rw5A2d1P1maJjr3ha3p
xKUw6iLEkKomjUsOOiEey+hdLrdhbfoKQyHWloT2heW9DQou5DCvl8T1LYZGFpHsiUP8qow2xlWa
4gFk9y57ktmarJ9yBQY4oT+NPjIpraIOPkhGv2TUf6hFRgLpT9b2dlwy9m7FCUH18BZEnMljJAR1
U4lyMMn6GKte4M/1dkhHUKilSW3fP6GV9SxeDk1LAJLB1VFWW6MJsu6CBGFX3gF31yteL9RmgREm
hPPjLyUK3u4LXFEJYNFB/bTUzlEboQ5LmeVEBRBZ80pYHzigMsXUKmWfAphgKhPv/gdpwBX+cIoj
60kpYJsMIHVuIG1qFRCz9QHqutaopGNnjuKsf6kAkEj/3qoXFmGMGAUVGwyN8utdF0mTPOOW4io0
5UvmnBEu38a5fir8+KEOWFXxFX8owosAdY02QVDaUmussgQUg40ieb4wWGrxmYWjOY8s7PjquV1I
oc4tl9q5qgr4DXF2pV4geReAb6EHLw/jHmEth9q+mB8TJUYnlifIc+dkQvGpDpi+ofkYf3hfOVae
+kDC4KhAwgEfL9DTiSppCIsuDmQQqo8bGfO/puixCvp9jqRP2p4MyRSnglRJ7tZ6D2LkB2mwuMAM
Q3fOUlOpKhaQb1kbFZ2iIAKgDLr0wXtNt77mYlbzfulLgMMeW8P/nlLRjE6hupl9r2xQHUgG1tDO
tXMFmGIprYFvCVnha+cJ4hX0mGUlEpaSSDQ+d/rkOZv+huAaur/bK+eKNBHo7BayYaR0qLd5k08a
33JIGE3cSec81Fd6lZFjWFnLlYjlEy7eXTEGW8eN1CLHMM/RRs/VLdKkveXHoMiAtykYK1rx0AuY
eEE2YaoFbvFrcUE/gFlI93HvFFGwN1CMIFLus2iq1vZNFFDkwLwebB+daNMnYYzaPlG8oI0Rzcco
0YNYBRp6/3hWLgIUhhBVL1gNuEvK7BoVQfzU56gIyHYMJoo0BxMOV6D0+cKP9ea+sBU9Xzop0PgP
wBI0ntq5DNjlVE6Rj/cxjAV9XObQW239lU8vTRo6PKbxsAaRrUr8mTsCZkOg6alQqzQwe1EuIHEK
xBcpDJNdl0kvTd1qJhpWcAelUbjtJ45DOzLotu8v9yZhj2I5emaR9vrpD8QAuGtN6VtRT4R6kM4J
eT1KlnA6xcR0/7zeF/PDi3bpPmgxi31c6H9V9KM/Aop5to7Np+HM+6ODv97Qs/rHMPMTiknDwZzc
kJi6Y37HL/fF30A6aPHURTRpGd6eHcQ7Dw7ZbuzOKtz7Im6GhNAiKMWJ8koNZWVZ4duxILP18XA+
b7ePwcYm79jT5923YX0zkh83hdsfoYCE8ctkLjA7UFlYLgHqrNVm6YxBWZhNfkrf+b/yQ7fN7QTD
yJ5jV9jeX+baTuJSUlGIV5GJRlh7fZCjkhmB38/8ecIAdjvNpOA9wIR7iC8x7mSYI/FQ6MbkRoYY
WIUqiKemmWrGa5t2PFg2PAG6uIDTQaKfZjip01xQOE7kz2XjxWkA32brxa/7K6Vd6CIDMTtaGDDD
Wr5puNQif+KLphLPY3JG3g5JdBY78k+cTBkFRCzNRGA1XSZdXO+lDloRVQQ6/jw/JOQt3Wrk+BHU
5kN6Rux+etgK+yfO3OTu4RdYi60S1ABEdLpDczjZL/3mmaFMqwteeP6X+YDwfdTJokcrUvKuFM9y
qJJOqgALkhme/Kbwik1FuzoibFCLgaOSrkGmGW6roA2ks9Sab7MFgiZDIyCvTwYyObudO7gjKDRO
LO7yFX0B1hfEXCrA+6ieUDdIoIuB3NUixMoSAbKgRwzasTi21oxxCXWB8gOD2i3fbzv2abDEoWfr
ofrof/kHbrf7Bn238shy2ksegVKcK0nLUV5400QZgrkMIal29nh7nQ07EazEcvcd0U1WEH8zq2M5
NMTv4GoD7TrQGdTuFWkl10MCz5aQhByr3O5FMgcbTDlwnO1Tb8okJ8184o6jSvrNi+sZFkM1b8Lh
n09ApwpyAwhqbg5wCpBfA6+OdJ524ukLU2BQI3fPYALgN9nWjJzctOaHgeHS1+5GFDgWWCo8DVos
qZs5Vvh2nvhMPks1CMrdblBN/pA0ZvxUbgz10E1mpxGRxTd4U17BYrHX4NaFrhq8QDeb8EOCTltf
MM71ObH7vbittmDF+uWxfPkPXTOlRphqgsNdHr2IAahbMeNiNR8rCYKsaTKt6hPU/SDJeE3Jg7pF
sY1wJPvs8Sc07ofmrzgyK0va8WQiLmiPhEfWHXoz2OJn5RcfRLmgWDDyNuVE49zYwemYOtGuMT8C
F1PSTgAT9KfYLkLiKQxzWn7rvW2g9But2z5oJLENYM41npIDDOmZoUrLTv7fIm6YSYROHvkUtbvz
1Ft5aEXpftzL20hhhFlr/vXiRFFPuHYMemc0jRBAzj7eYgqZYfaDY5xk0pxNhM2WicTdLmbxjS37
c29x1DUWt3IWdMipnCFzto2O9DyQHp/taPqmcr5/KzNUBIWL6xXmQaLIVakuOivuhk/JQiEhdjJT
UclpJ5m2+oYZvoSxr/c1BBn4a6Gg5eHiOcO2WvWWA/nIKTcDhhKuGCNenoaE3OcCFkcG6loG1zRg
gh184yxZEsk3+SEbrXkDaP8L94A6/i9l07zEJeEVoinHIDFVzL5JTAyX67bzU/mREhB1Juk5UDb+
3/t7frt6oA7QmAgkG1JxGAJ6/WV8OwZZEYb+ea4stTm0WrYtZIMIvW92aeporFnxt/oEeYBAL01U
8IN0HnjMeRHDFxL//Mbb53No4kH5xrqs1eXIrpX2Wgjl+9RiwqDJGkJe3x7+Os5eN/cZeXMEC3QK
mVtsjo61P1qO87C1jsfADR8e33c7Ozx9nk4naZc9mjzxMGKA7HaRY+52z+any1C6nyFH9z5xOZeL
Wz6IZqCXFXyilZHXry+DOA+AUJG34ViR8+a0s01z3u0Ec7bdjuyQ/GFFa4vK3XwA8i4/49QRa1OO
cQZfjFjXvn+evNnpUQlyZ3d4LyeSusUD984aIrl6JP+Iox8zGTAEyVyD3l/WSzNW35SK8WxYcY84
9AsJlCYHlYTxzT0k1E6+jRryURHernaVaZjhCSTXZHytTRaP/crbdyHSQAMizHqZOktZdlSV+piD
9ee8t96QsyOy+RAR54lsHg/vB6jTi/vtsZTnprviJ4ZALLpUHdDHSbMnBg0waA2aJM54VAjWNra2
Laks/+H0OZDC7mwNsdzz531H8ZMEpBTmJwD+/0KpV76ah74gtxBaW7CahjgA+v/1ra1zfNv/Maw/
fwrXGnqMToPZ7HLTRNGeYNyrx7CctXO++g7KuHUQeHNthe+QP0LTKXapFXmB5z9uyfSW2+ov+Ys7
31/6io+8kkjZKnJxyhRXnXwGevOjlIi6BWyZFQWv2OOVEMoeg1hs0kKBEMt4+FD/Ps0pGTc71/Xu
r+U2WEH4+Y/q/KjWhd9BflUba7GXz/omfHh6lHbcn/sCWMpJtw5MUan5vAEJ8wP/0SIRJFnnGXkZ
IluHcTe8pcR8YVFE/rxfb5RTBawfiUoR3S+L+7lYVjJlBTenE3bvKDgfzjawz83xTDgTkxv3TxvN
3JiK+czvJwJynW+PBc0SV7f1Qv7ySL2Qz8mjGGbKuBhHRjKCJNGHU5lnBC/HbWI+/iJ2SU4vz+Eu
tAfiMc70pgnsxx9cSKdMExFaHsUJVt+/RZ/qDpY5uiN5glO3H38diu3ppJghi3Z+zfUBPffPnlOG
iLc+frzseUIG03IeFPe8VTkCwZptE9PcfU9fy44HluUxrOUne3LvvCmTlKZGRToDsl+Pb4FK9Nf0
eUtmz7azx0/0jhHkGg3Ls+6r9koSAMZzsWLKRjEGCS2aGk65sZ3cOsP5bWSL2O8aS59X3sSQhBSc
jEgJc+3oFmbViOIcI1JwojCfL2G/3aTkMJumHRM3siaiMZZ2w376o0IXAqnQG5UErQVB2HKPHT8a
soUOPenWk2ptiG2KS8xqIgHBKjytRPzX66TstggLILiRDkRSzDqWjiBv05N4+KOd9176UZqwFcZC
1wKvq52lLFWbs0IzRkjszL3lJG616d3xV2EaT3/jlmxaQuzPl5f6iCYZYmw95UHb6nZqyyeWCi9G
eaPCFztOGa0InCVm2OJDEoI9d/rt6JMAfjI6HA7SriS7wjIji3e/XZchev0KvRBNWW4VqwsxNkRX
9utbbx0TxMQ1ZroQ3vVclp9YifivNpwyVdmX+rFv+GWd8WOfn8GUrGik5u1EfVBZ0JZ1E71YGmWi
IidxRVku0oANx+h1l39+3zUCMb3AGghDmVgbSQOllVDhAt+fYTVHPC8wLpFweDi8lCYmGLssN/9z
c97RGLqBVK/1epZqOD39WO2IeSJkQ7axs938ho3mdmRpW4bDW0oM9yRS0W0RJkmUtJCooID04WyS
rcuQsHpx/nNedEN/M7eZng6QUFqO4gZEONn2aYfnDiIfVrJz/Z68EEZ5m0hSaknJcVy9pe8aIprW
+Sc+eNStDbdJ3czhLM5i9RyvBycXYimXExpZLGKa6+Lk9sfjUTYRDzlb3SLkNzkMFp56Ozdw/rj7
P/c3d/2GvhBMuZgU01zAKAnBr297hCSOI8DDFC+cTTa/DzZelbtnzsrN1IxNRkjCuk9odEjcps0g
DxCNGQqPqimQ7XaDy+Sgknf70zafkerz9P/wBLx0NTf13UmPkcuGUNB1W28423NmPm03vrM5iW7H
Ut3bRP3V3UVXyOMwSQ25g6vZ79XBrM1nN9+4e4/lP1cy1VdyaIByq9Q60NyifA7fw2fxj4oaKvc+
kL3HUtQfso475k6jzEZD4DAxUoK+hAflITkN9vHYvdYHwfraYjx2S56ecD8eTiIZ7ZNKEM4fbG3z
7mMsl2maf5Kv+/rLcuZ02iwOBmHuFnsVbYHgOElibg42hivY8tN9UesB5T+mYlDxT5uDmHzssMmw
UI7wnxjJTgiJTKjry7h5gbp+s0yE4VxpcjiMbMboplzBm6V00gelPfHbU2C6JmcZ1rB/TjduYBnv
3KFhFSF+2izvnTPlkOI4UOq0xWKTmlga4c2Ws54cJCe7DUar5CpxAfnB368KgR3trf2z+2y+v/9C
aDKb7yfTZJnSIvDeB1GOKpSrOix53ALqsbK/OLxctsKmt01kTzrC8IqsCJCujOh82YRTg31PvoEz
sZFwcxrysI02YEIRf7/DHbvaAckMyzU/kQ+Go7yva6zFUgGRGoKndoplXKpfvxMW3GmlwHTtLagA
qJEKaQgGnG0MsyW/N7hOP+37C2A4d2A4r1+749xGGKcJz6cEe6cimDSWPoZmgRGIKBsCkt9t8Ahr
n2JiV4bLk/yFYTrLDt2oC+hkgRwD8BCly2v5vN8BkGQYMNb8oHzJv838yJCwGpZcSKACn3qSWmAC
ICEJQS586Dtr4kxw8rze38n1APJCDuV2uN7XQmmGLvIm6o/25vHXL8F837nfiFWZF8myLfe2jQp/
srYoMDMYwloDlD8POlh/X4QZQXJuN+dp3+m7iDU2fTHceyIpT2PowHY1mJtzjr7fmvS14HYdq6d8
/a18sYeU86jDuPGFTEcll7wh9fKA6Gp8enkB0ImVe2TpHfVu4sc2UJsJG7iPcmvey9asWxYzSmXp
HuUfcjGJ01DQlnDxzZLtkSfp12jvQhJZ34NrWIH1qpsMPVyXCa6TZSwV2rspr8HHBq4iOVTOlmSl
D3CEuIi+hz0eMe4fZsF/MZ5bpfhfYTQ5Za30XDEkYGVS8Oi3Uh2ZQZ2YuUyYklavWPCD/8+yJMpR
VEAxihh5p+B18Xq0DFK8uayEwnqQciGDchVTjWZJRfR/UhgffUgAntiIZOdyVrphuQvWzlHuopgx
tHMC//7ZcI+WBFyWI25HO3s/dXuGqJ9Wk3uHRDkLQELyihc5eEAc0lKa+ng4dna5tRrTOT89PW0M
s7QPm8N7dzh9xmT3/e2lZsd8YbNOkHIgo+GHgV9DMQ0ndxzQ9G6dbivuWSDCFYQfrs2LU6ScSBJh
YnDsBzCAfW9VuMiQQyZbku+RD0LtaGc+56bnWR3L8FaDgQu5lEsRBtDLSxPW9/p2fNOc7jh7p5dF
fUzm62jNey0wHxWEreCyo1HefddXmNiUKudmh3JoQVSMSne512grvyHQQrD5Z2/ddyuLjtA6JKIh
AZBb5EZBI4SfX2TFA74q6zqTlLOsFkTEVNeRBeNZ/BItATxXQAmi/iaBWvJagpIHaA/llzWRUiA1
MT+Fv6w7bDXcuRRC6UbfhSmn94VyxrZZH81ncuLNt332fXyLgJNCqseaDq7JciyrT5JLsZRqyHKh
+uW8iD22VhiRN400ZmT7ZwzttDZmerJbcwel/HP/0FazJJdyqftHLrqZG6ZscZoa1ov8Uk/+Pj4e
7BeTnR1cU8pLYfTFU+htW6MP4Dx3pl6dMn83f4bpBi06DmNZa5b2j6SboLVtlN4XxWU734CFln4l
h13/8u0yw6zVNN2lIOrS6dEYA54yCEpQCbJ6y0E+3TmjImwTQDwV02VY2WrIfymQMrNY1lu5Ww4s
IU66oLzN7z8JYVXwb+jJlhLBpRjq8qmNsk8bPFghprbe9I2GcrcGGFe5xxyRmFgWK2D9Af//39Yt
0NCcOQ46cD1CInL1b0eM5rXeOJevwMhlqb9Ny30trYxMO/y78Qbivrzs7Nn8lacAZZsvz8xM9upV
f7kDlLeRpGrsJwnfg6qTk9nFZnzqbVcamM+CtUgdlI68slSAADCgThRs7kkHOnwIwgS6o4FxSATT
Z1AfeGYZ+1rgdymJOlS5B7tD3EHS/IzwmUtNjRgOGlwbwEDhTpdENoEyMWxxzeovpS4Xx8XFYIhT
po3VqJxjg0yJlW34Fqmz+RH1npCAjBTZ3z+MoscK0tUArByQT6DKNQEM89cy+64Dm8mkKOe3N+EN
oSAAj0QgoaMYVulWteUTW0Em1jM7F+3/7h8WMfbNzKvFfi4/gDrUXvYRJoIh6ww8pv+ZlY547l0+
NIPsE7M1gK8t0EkwVRsp2tzf7tUL7FIydchxPXKgQsPScxD2v6JCy78b5uHQIfWMUINom18mD1xk
6GGe4X3Rqw/cS9HUSSMhG6hpCNHlb9Ee67MsblVA3TsfOLjBEt/1d8MweX+fAC2e7orn/1RJ1RZU
MQ4d0/joUQ+8kWPhc6ghEe1E5OH4WjwFXpiSl5fhV4i6JsOgVpEAl/KoBWcZ+jk6DfL2cYn4PBRM
9X9G1JW/AGdG/ntyDruBGAflMQFaJ9xMBKBUiTnSZMXGADlEM/nCl7lEYdf6Hgx8ohT8rJ3T1Nzz
Mgk1b3CUHVggiDu5w5fnyTMBcIdlZyy5y88vbBujfkNfznoNz/HBRNVBeavIh3D+mmFrT/JWPv/O
iW3v5o9de3S57bdmeQydY30BFVNUrWhMuYgvCFzl17zPv+rc9l7f5N3bvtn9CZzJZRz6mpYvnQHo
xwNZEkhRqTVPZdl1GWBi5yF5jM6ihYLOtM+cJY3jNftwo7zfX6K0WCx1M14JpJY4pTk423sOWgZs
t5CZofkwWpHL9zb3km0/d8/+6Xlnk/D1p74E0AAgA60VbxL0EDA+ZSWuWjqc0TOko4/7toOv0PQR
ZMvcWQ+cZMxAXHXWv2puU0ePCvqUhHI3SO/FrBFl+M4KJ+m8eLAiTFyJ+JKU4mdVHpW4JjFcYLpr
ZDeJD2D5yfKHXjf7cculnSnq55rDtFW7Ckn6N2PhRdcqLJdL+KmLXKjsVBZTW6o1dxaem2+p3YLh
iGTbzjj6GJLtcdvKN/vufH/f1sLEK6HUfTTNqjDoWcWdOd6qETs58R9OsJU9+rYnxyT6gykc+fML
DyyLx4zlVp7VV8KpuygNMy3ElEDunHcAGz8nKW8Fj6r0NJVWUdWk5J7EnJH2XsN6XMmkbqFK0isZ
Q7q4syKaVeP4uimIxOj+9vsvNbalv1W97X775LemkFmGT6xigXUbMXRVppzznHLofBOx55JoxqL5
9+lhKU2W9sjZu3wzkGeXccjLPl7ZKawCfUk6qHEwZVOm4XZ6p/McX4/+OdBN51icyme0uTqaRlLU
C0+22dtA9JjZA8MofzT2nlxKuepSjxUwnvnnRti2v+p9sEBLnhpTcpFIsc5HHgW11CGbxtmcc8vZ
BJsY4XMcbp9T21AB3sQQNVN6vL8btw+Vn91Atw02AkMoaDcJopFRVX3RP1evRgQmtoT0Xyg+fVWZ
VRvPHN8RtWTEPrc9jZRMylPqfevnoG4B0Fr7Le0NTzF3LyxAzW1J6VrITUazMFIJnXf+GUmyzMWl
p5G3fWn1oa0+Jhs02+iPmm8rE+Ets3JwA6PI9+2CLmT+1xq+fAmg9aAbAz0i/uf69jWqqU/FXMVy
JR8F/4evBx4hfdxYuY8Omx04GhhnevOAoARS+8tXSg0iIcU/j7XbtgBb9/+Ps+9act1Igv0iRMCb
124YgnY4Q457QcycM4T3Hl9/E6MbKxLEJe6upJUUqwgW2lVXV2Vl/q13ym4wiv0+PsFlm+gdX/Or
Bbv3cdatXWX0cFc+O2myBDpkwK9vwsvmPdynJDa8hISfjvkW+iNYDiiD8fWiPR1fouPLUpAxe7L/
nehpZ7capREnlKpzAqkRW5KKhfwwc4yfENXAYT+e5Pv+kXGw6FcFLxT4OxV1koGq3VqrWNFjThsI
fxyDp2TrGD0JDGCaqLhmjU/gTDuCfuQB/UAf4HVCfR69XC+Xx99xH+dMvmMSU0KZRE1TjnFOTG2F
OUkVg9/SUPd137wERpWTy0Y2Htu8b6Sd2JzsaNVjOPD2ucxJj1Kim93WjP6cTD8kJ3tHWjClki/Z
XPGbdf92XK0iQ/n66vWvM6Lcpch23MpTpwraDsCLoZyB98Tk9tDc3C2dHpEOekdeXSQBh1Nz8N7j
PSSO1qrV7sCuvY4M6E4QcaWtq89gXdB1zhF9qatt1qtdf8okE9ELoCRzanxKGa2k6g2SUZIAwRmX
I0GHbvsl5tj7tytEcCF/grfLOHY0OtyetkxtK6FVccoRp9R7+FGjW+NYg/cRBaKFaHrGo2jjbamA
GAhGp5QQMavEqSZjk0kV7aPXLNkwKnqh9tpCBHaf6BwHNRLtQ5UIZD3T3tfKD+oiVwIEJESPn+vP
JkR6VT5Ily9ej4zmvELKX1kkE7jPIt2anYIGm1CBKEYcMsiv6iHmUgzINjdlE0E7fX18eOYcx6hN
hIcg/gbGpdGLXXnJsGu1NEhhqxmxHcdmZQqr9hx+nkZ/QQDmyQhnvIhv6QH1KsBqvnFs2g3I5/TH
HzJ39d98yCT4S9VcqdMEH5LLRNwH2lqGzhTt1GOt/KloXJOsXaDnus8ejvN8NfbJcQ2znu2GECZf
N7tOz/6a5ufnbrPZrDIak/KQ4BTL9ND/nMqc1GcjPnFjViD/wPWcLCdpR2sT54FXOLgVRupi6FJN
TizHpSEKMBJzilyjzl5TeTPq2VXE08xas9SIyt3e/9A6cJJYpbaU/B6d5J11XCFIlwI0gf7j233A
ZZro1XULJ6oQZ5egR8mnbqC3Jv8HdfIUzX6kW4j2ZgeMJZDRhcxzUMu9NZkETBiC+5s5pdyhwdSy
6RK35X2rCX4eSsYYE7QOQTowndPMcbu+rr0zr+4BMqBxYAsh1LHeZbGnfGIyNDZk0AE47msifKgb
YaCY4D5bS/xGCkDY5ixEm7PnbSTNBbc9WDTUX5dzdd54jStSH5iO88Acvcru8qPYnrvurUR2L6Nq
Svn8le8rIpTvDa8Hg2I0AxleA/BmKrRBj7LiprowkCz6YVrqg2JySM1W3imC3gBj6FdL8eIYOUw3
BiZRggjUP2yat6vkKpkjRn7jngVTcXTOjN5FBQFjlZChJmJKVcFICit3aY8nWvwUuQshxW9AOv0A
ECpIMjjnQBAxxRwqVRuXUS555zhBDe9JjQE5QxyX2O1XJert11CBb6V8HbIdl39UGYgyZIo22e80
pYCuBDkUbswYLAWmWtEaarGEFY2U+Rqe83OsUc4lrPwsagS0T73BSkasmKxAOcvZairVzC605bds
oMPet2tw1XuE0/R07cmmgw71v5DEik/VzqGQKgpAs8SQ2te9r9bVA+fvYw85665AUjXqQKrjrp7E
Vh5U5iXWkb0zE1DvkJPgnafq2qORbsZrhuIA6QbwiAl5Ooh6tAp1I3teh+aX8rVSbEmvTG3Vuovp
nZlLEjprYEZGyRh9Y+h+ud0gMe+JCigBccaGHZcRf6DZU62wRCrcVZ7vmp0fUyYi6Yua6gmzkpyX
oiPNcyXTRQGl+xS+hm/hVXlkQkQWfxoG96hyJUMf+OcKncmZ3XN69IUVzn+kwOxD8HuHp8KlPKcz
0nqMg1pSBg3pUVJwQRIbmYytSTQJDa55a5ml6PAupYKPG//AWULcgmr0ZKJALh6mbeyfPZt598zU
eSqDFXsp8fTeOznJ0FSdkpD5M/zE4WfA7rQAzQLsiv+vQdDjd0ANDCQioOSFFvrtd6RdJxdVW/jn
qH/SXnB8pG18Rpmh7o9M7YPFxyx+ZGTgB51VrfxFaRbu3ZmXGYhmUGHhxmtOhJD47Qf4TDwUnMcE
5xwAg4aWA00Vmv6UzltqMP2mBXd+uW1IUe8RrjLFc5eauWuAMT39dg+htHMYhH1mGRyC56qg0sK1
dB/E337d5FoqOq8chPHrKrTrejTwcTHBBQ87LX12WNJU+uNzfQ9PA7oDb4WRARfSgWi+vJ2OvBjq
vhq8+Bzw28zT5S/WMepAz9lNunMcEy7GP7HFihOId04DOuTEXUIw3Cc4IfkKLWUQ87CogEHJ8PYb
nKQI2EYIkzOkMlIkI5wPQLzgXfX2rbajM+suXCvjJN469Vt7ky0Qy1nVOQHsJexFw3UH5OTjWb2P
Z0YDImJ3RFKjnNrtgLo44RRXS5KzRjSXZEi0f/9/dKeN03I/jH+tTPYK56CrUnaL5Nyodn3sNoJZ
bbQ1ktVusUp1yCnVC2dn3AtTg1CGU6DnB0QLCEtvhwW8R8UIgpeeneJSeWZXvTZLgggzT0fI/17Z
mOyF1Be0GqSW6Tmz3yuesMFGPjEWuyl6VKX++1UC7x1IHjVQoUJ863Y4jha7fNVU6RmxRN0byHYl
wUksDe6VWewknFura1uTY5Y1OegWhzI9K3/aAn6HsBvP24bBK1Md5PeypmVjRkskiTN5VgSeiG/B
kYjYDg35tyMM6lxINF/Jzl5DmwEBhPIeJnbDmFlDPWHblHocGuyTcMmjgSCfXYUnt14xR1fbMtKn
zwWE50jurlTAsVoiBTof0yhZKcp7xbzWoNcvDbW0Gx/ZlnWPyAQtej3ixICm9YuzlCu9333IUeLy
Gjc8wunpezhLhMYDHX5+9nxdkj7TZCfWCw+Re+8LE8ghIIMwcqBqYzh6FR9HSekwjjbkZ7cE63j3
UgBm4D+zrbTq7eQoPz/ef/clByg2w0/IYJdC3IDMxa05oOGEnmXL/IxkaFMThaMNqKAtr97LdqkX
z9yzhMZsLQwRb/6Vc2tJ+GzmrY8PwGkelbsQr0xpL4IgbmPO7zDeDmA7UKK5SP8DOdySZueUVHuq
V5moPx71TJh0a3TiRZSuZYHehNFdd+LP3+Z38BINerThwDizrtDYYRpUsUBy8iLZNGhWj83PLTH0
GaHXAZJNFrwet3OelY0jcG2Vn6VBzxyIDUAipAOqWNP05MuvqFSy9LFF6T70woBlsNeOTKIgyJ4s
c6QJlZPXfX5udKEzU9QVk4SDApWhXvLXGlRFOdGMhKEOq0eJwflmnZJWpMMzcDbE3/Qy9FoN6SsP
kMPlex2RGdStaKHS0IMWKB1cWj51P0lGO0BGajvLvlWf1sOu81ZFvJK/oezVMKs8MzK8TRaZs4T7
hBgoPvBGwsBGienpJuI63leHRirOnkDYKqJR8RbE1M3NIuyp0H76qcU6r5pnhh+99NyJuti+CD8o
MkmS3gY00cDgZgqqocWrAOWdEoDrwm4Ao+J1Fk9RlMKUldbpnrKpOT3VTPyfEvLZjxfpt/nu9m67
HcVkV3J5lEFsSC7OaGn3NV0B4EjZQRFFG7blZfgGWgIlIMdKftKIuB+DageBySmW01NFXZUBDYc1
z1q93st6UK3axNKGp4jdioyRZmbhUO9ZEg7pk/LpPwuZ4QtvbushvCRBb7gH8U/lGEq6jQrivHXM
prAEeS1rRwWPup88sIpYZ/zXULPK8BBy5sCsnNDkJVrsU7y5s30fZEYIwVYR7LQWGiU8/Iq3ZiQS
yFSA+W2ZG2xhcg3t2yfvu/b0XOORysFfTy2wr560MJ33vZ3ILlxvivE+vPKkflUKcqGKxZlfB/aO
eT/UVgwRB+TSLFYHeadHZIS2ZPjJaGTg9WokVmH55lL5XxqXbbqsMpoGEF2CCIX7fQ1cfUfeMB6I
ydTiLBzai/In3ef7yvZMDiQQ7inemgmJkWSjgxnuXaLsJCvYs2SD9Pw5Im8UbJcOgSfKV+g1ZOlr
CBTfSrJ40z8s6d7PpCBVaND/+6WTh1FfpEJYQqruzColTcrL2K4tvyTPkoVVDU1vIRc0d/nc2Jvk
zPOsE4TCxcxwh8IsUa8RCCrboAVRdc90bMfk9uIhWkVWveCBZ8o0NyOdliOFhJVj+AzsjWP46m4a
6Xn4EHetSsuSyPXH0NuIO1I9CNephK3Bvzw+6vwYfT/YE8LkqLeh7GD7Y6a1FYjEXdoh6Qw00LuL
k0B8EzU5XbDTTUKlD4eW69RIN4I9glMef8f/Y2/KIJNFMxiI+SYrIKES2sbx+B2b/Es+lrTbJHox
mLyM1+cGx4VFtsmM7Cwh9YV9y566XM+RaNlXf1mI/P1RVnEMVdZ1bqVQWgiJQ5iSaDllwGxUm+Ou
CQ/tieGsdtg6FNrperN3eVJ/B5AzMId1qDvKwphmwnesLcQzBdys/CiwfXvuubaPtFjxyzM0f70O
weNFTjWqJtGq5rcsm9MgZ/aF8l+/mmEVMRRyCpAERm7h1qrKNrHkSw72smg4Ealfu84jyqe3cZsX
eYnRdabaNFqDhDViNhSBfn3ftU8ReUBymKA8e8julD9exZtytSvSNwCDxGw1BH+kxieVYPnumq1p
Arr6xzvn/nl5+wGTXFzg1V7LpmEJgT07AkgUYbddhbZabpYE3GfSfremJl5JHpLCE1SMlV3vmENw
Gkz26wDqIJnGq2psZUPGrxrb9ulbDSqf2MZbjUQ0oZXxlZHcvET2qgbTDxrQXXPpVTXzIrhZiMkB
Qseg0Mfi+HGhzWWrOBCJ3D0/nuuZLD5iNqQX8SBAb8rdKZUTGWnPyv3d0UH5kUunSFpJhzgE/6py
lvtNXltMZipgEmKAmNjlFfK0RtV9dOBF7C3WX1KQnYu3IMSINx0+BxWbMdy83n6qG/WNjNVXcIXX
3r4zW8R9iJqqhkTMdsgoI7FU1QDigVrJEyQZ/kbrZAnAObcH8bQEK6OMcwdm5duvAFpZznKpwh4U
QWicm473OqR/nBIAA6dbUDCYs4U+WhDUI2+oQCL71laehWHbyl51Bh67+oNAhkGGG8lC1B+Q+X68
3jPJKMChRmQqQCpQOpcmb0DoaTZdOuTVWWg3KveuXhhwDisKyH9I6FqCVFLVNfIyXPPhQnpl9kq+
Nj0515ycxZmfZNW5+MN9h4JAhV4XJZpWKsijfFpCdkBPX2TJ6val6NMEKIO02KhLD+25Z+HNFEwO
fZq0aeBIZXXO9M4+BS8S3NyHYkGNibgHRecXjtisQ70e9+QcN2LmZiwHew67zls95Hc5M8phouJy
rFpbrSkXEpajSrNSTlqz4E1nIy/0joy4+98LZLLimjA4KVPV1bmG5FOcbTLREHPqdLuskowCskkl
hzaAHOJgp4W9Nv7yNBK5tjxZ8D6pZa5Ei9E5KFuIdiEoVmIaD4bLohL4E5b6UH0l+Z+4fynrDa/Z
bv8WV7T7ePwZ9wwwYykQEbIAn8Ky0KC4PV8hlBmlSMEE9AiCn8CCLup8QiEkGxDtnH1e1P1RQg3H
Nzl6lux4oxqBUZNyJdn80hGYc27IBkOMUOZG1spJ/OCFfi3kKVx6E372uyY3kGZUx8xI364TY/hi
0k0o2opH/XfuoLZ6mq0eT8Zv9He3JpAKRIJAxe0+VRjl5dAX+DIuz9x7akhPLRKCFR8RkTVYf4N3
CiBOpQW8cNmZ/QbcIpYToSQf/FR4ba2LAnUw/52xuh1kcaWOKr4F+GDTHh9/5ZxHRE7vPx85OaGZ
k/NaIGGaipT0OfVxu8abPEOZ1qWIGh8bu2+tGvcH1NHQnMJiu07zvhIXe4lfFrgCKQiyZGIPOsqb
FlgH3sNTb3sGUn8L9arZk3FlcrIPaiUJwV5VlucqRDYRD1fP2SeBHigvC2Mbfcvdcl8Zmuz9og5S
LRZ+x6aBaiTb1miLE3Rk7Y0G7bxgLt0KIDqLjASU0o9tzy7iiOj9bWkHMeTtsYuSqFGyuinP6po7
tG5EiwFWgvoQKQsX6HgZ3w/yX0uT+Jgb2kyLPFiqEhDJtwkjmW6Zvz0ezuzNCQDgf8YzWTNXCLhG
BJnaGSm1M/MtX4J8lQDDIWzlhLCp7e3KJeHSmQgQXPUiB31cDWJA4sR1163vikojgZ668owAvjHM
PiRhYY/8Pkgn03djZeKma6dTfZBkled23VPRqH/ykQs70+tVblR69ORuhO8OSTmOsmZDffxdoK3d
GKzdoQ+224cvSwj5ma2DXQNC37FapqIH73braIWEzG3AlOeoffMVkeTNsUFbqm8KeEO3Tac/XtrZ
ab4yN9k/re9F+cA45TlPfuoU4irqdxYu6YvOG0FD0LicEPqa+DRE4MFQyRhTrdHQucQCuinCJUDw
nBFOVXGzQJkVdfDJUmZcVzN9ENRn1zFcUSJdBbLzpbay2Q0D2A/auVB+gfbcxAr0vEQGkWJ9LvTI
7nROF388cJAOaEst0CZpqLZPY1s9hDaejN4zWMZBb0iFA6AVhrji9YJcHi/gDPIHEH/k+VmkGlDl
nebBtNZRtTxN6zOXkNzKz9w3W+uuodHSrJDjUiiS0mg4FlnQeOjSdoPGK8UU6aZJadaRfBMtXfRz
O/j6gyarrYSDVidiUp8V7tmXaRptmHbth76uQs9LdAngaEhnmLFKeKFdD++8JUNs41XuF1zjDIIE
MyNo2ohbBgJt+pDpuA4ydk1RnzcxCu3gDrObw7BSnvtDj25oJNcjIybNVs/W3K5YuMZn/PKN7XG3
Xj3lHCFXm5DFqnQoqg/cruqW1NjGnTZ1XZBMGoFuUC+BVumthX4Qyywe6vosxACadbsq2zj1Kiqf
RMdc2GKjE7g2pY04HPQwosYBFB/+5daU33CqUotue3ZbvXoHnAmQLAvAigTkjzs0cvZbF2w0Km31
FQqLj43f5Z1QfxDRtwFk0ihnBAX6W+NDl4pDFuXNKQ3s9wFHrPp2DiD7brfpwm0w3bi/lmRUCSHK
ghyQOH2sRLWTRgFfn+qI8G28zlp25wVQEvOqY9DbQM4uTOx0k/xjEORvI2wGzXsTZyL7LB9UhVqf
GB75YPQNNmK54N9nTYy4cZTegcmZgnJEdoiSUPObUxSj0st7aH5ZiHWmfvd3EGg+BPxI0lAIn8ya
rHlMEvtFc+IG2WS0p1wIievmC+O4KzuMZgAhwdKMfY4Q7L3dBrVcc80wmil02Sq2qqWu1XX7qq7d
FacnOmMohg9Nm9zmqGaldravbW8FyXH4u4UNOTdgoOVEFsLOSFv8OuSro80NajkgWGpOKLT4K7yo
VNARkJiBXNLGY1fslk/t+jvdlKh+/PemVQ15GYhYIDGDGZlMAhsFaqGF3UlGJcE3+l3K0jTY18+h
+CKVJ7G2G34n809SYgR7MO0t2J+6HKzBKCKE9KiASxzaRRPzWublQZp3J9/3aM4A96ieUY0qRbtU
Fl6uwrietz5ntAWQvAocB9TWJ+uttiLTum4NWwpLcLVqwVFsdiKKdYyjj8ApVL+UJtYDvOBkxYpF
jzbVX6c0ZKEgffHmleswe23LTYRed2ETclaaGE5AsorK3Bow3BeuWsupwYVAO+bi0t1z7zJvP3+y
UlLhtEyhYKoqxebRA8sRVPzc51C7RCHRBBJpNFrQ8L57zP2zPADVigBTYINOTqLviU7oeU13ClW9
KlelIdSbbNOsedHI3lLupQdPkmY34V76qIEO/F/2JlRm8LhGJKJNA1f0+lcKO1TdqS6eRegNF+g/
7h2C40wcwB4FjvDZKlEL5GFsJjC4lKbtK6d2C98xTuztvtHQC40rEV4C0aY42aMyEDN4WHbsic1C
hma8GCPW7JMFJzC+Pm6sAMEBoDUY/yFVjYfR5FKCiCzTd2jJPkVqSIRo1/dmyz5xgfF4Uu96dXHa
RtlykMyNduDFb08ctpET+vjPp+6gvaQFKdedXVKUg0/OVmVI4ZJmHW+3H63db7y1zy349rsb8de8
gosXQKoxZXprvlEaKOulMC9t3W7ntwZEzRsO5URuBOQOC6O9Kx/+jlZEFAuCQ0kEgvPWXF/LHV4j
MMdlp5xbKfmqTIxYgA5TQPxSodWQrTxxoGWc7YK6/vLz8gv6VzTorXzJzc+uMHCTsoyNhIfvZOaF
IUxSbvyWrgB5cRdZQ7ArmKdQWBz1OInTvQR4pCDz6LODe59M8iDlIgqnPneSSkPsj8lJTKjKPMfP
/Fjf9/CGKXrdrQ8dwxGAmPQwjBdC9rllRiMSsDM8chWgE7id9yYKo3oII+7UxxutZsD83yiAuFd/
guKJb5egWHdJyXGZMa0qekIgMyDf3WJpn4Sdo7DgGQQdCnndQMDm83CwT3YDZurtW60D601ePPRQ
ro6vj0/U3LJe255MdiyUvOZ648Ht9nX5WmxyYP6rwXps5Q6e9ztEqFIKAmK7scR0O6N1EPttpSTc
aYexgRxStPDMgbodMVNqgevfskIQRNsnjoTGQEBmdxYM/PU1Nt335LLIIHT3bv3ngxBCgdQHKz0F
RzUKRKFz2WFPegNG5ZSePnef7++7kA60Nlsr16N9YW1WLy/7/RFkW2+P5+Ou7jCahwuDKKmmQvnw
rmm2BRa5C0vupJRGeY7B1hDJBRWQfg+SHGqHAuERQB6b4SNWkrX2tGB+7ogpAOThTgRX2x0FV9w3
LiLLgjsJyGhGQHcXq8KLAFc6as1n18boUz53vGRUErQKQ11oT3k8CqE9/ozRZUwP+kgdy8O5CSJw
AbebQkFXUuiJHXfiZTONjLxFUfsre+VDs2nPPmKZx+Z+K/JTe0Diw4ehgxLFvIkLK2pJLbOQ405y
ug85iKBaQ6fhMt4Pnl61aAAYpJUQ6Z1jao5eZufgVZRkIodWJ5+EmMjuVpZoB+2hYDDYhkIeLi6+
Ae2K7LTbDRBM72MjW9L9uysZjVsFsSUWCw4Jz3f+dpb6rgKxR4Gjg1DBex82Pmpi4ooDwdbLBUSI
j+doZmMoKAQCljyK/97xpwD2FkYMJGlPwjuA6aCg/nn8+zNLfvP7kyUYZDdPBL8ChfpfZD8ktOra
zUaVrNVjM3eB+VhC/XcY03BEQ2UlaHoM4xNPEL3X64XzuzBNU1xNrPRunjP4fU53dG3HfTz+/Ls6
Hdb85vsna15JfcPKDX5/pIdU8L92L64bm3g+TRdszVwAN6Ym7wpNaDMl02DK2X37hrQLjo/HsjRV
Y3x69TrMfEcS+vH3+YtnolS/2GazZGD871cG/D6sa2ncUiFBOxoZtiq6jfR6i7b7y0g7sEwKt7CJ
fxlbrywOjpe0gK6JUB8qIfKmkQNH8AADNuQPoHRGb3b71WUJQzUTk9ys07jlr4yiQ1Eo4hjDhHaF
TJmvlfr89/FKzV1K8DHILiE7iAfT9IkZMnIZdqN21o7dJS8cTdcNqZ8CaMht2oWi18wBvTE12RWB
73eKmPRQcvsIN4oh+oTfLPGsLtmYbAytQbLCE2CDzWlJibevlyZsvKAmF4qKxxXeA2h8wZN8cna8
SGErJuLGrQdAHQVmwAJDbU+W7Nw9nscOsis7k9mCEAQvMrhGTy6q1uKX7dqCFT4BQbtfInkYf+nR
iCZzxoSZUyQ+RgQyfmfhJTq7HlejmMSAeB9JaRjgt+OSABrbbhfTQUvzNDkjYioVWTnKKZ0g6/oM
5LhoCmgrSJ6XDuOMB7hZkPGwXh1GGaj2YvBgaOM+m98hFYxWXwiOZs77jYnxE65MuBKaFQIG1P7y
euduHL0xWptduCZnfP+1jSm+KgA5qhyACfHkP9dW9KrpS6qcswYQYoNpCDG2Mg1zlcDlHeCqEE4Q
TneBe37ssZZ+fvI+hmRRlooxfr68BE+pNfRQRn9sYS76AvTs3xFMbmLV4fjKgQMY+/VTgl313JGf
tWa9rKKFBV8azMSZKH2aNB0SnSddQvKkpulpYSizpwP6siIyChD8nQZFURh7Tc2Bzh4UrinxyU+p
84uybjO38Zj7/o+RyZJUSZ83UQsjnp4Z2n+dRRwd4dWvT1aDVXIp72v8eoqXMk9NsO1I0KhaioLv
6vuIv27sTNbCDfwmLBPQu+sQBT6+JrZkciuuXeRCnvUjV+OZOPZ2EFo4LYxnjF1iCMKfMktfWPZZ
t3tlY+LSsR5s6gcYy+srsvIAfiBegZR35RJ+ezwel5Cqd9C+6dyN+/zKcWmyXzkdbveTv7J3yjM9
v0AiafO+17fny+OhzbrIq5FN3H06ZEXrhxpCy2NkivZ2AIXb0nCWZm/i6UUvTAO1wmgCuyT+dn05
Ph7DXKh/s9Umfr5HVzJUdLE8u427T+zT6bkC3QNZMDO/0TRwn4EZkgcM/3ZRhlBNikqSRmHSBM2R
P+iLOadLJHtzRjgJVTVc8iCVm4LrGpCMBGrqgVeXqlZvcHgZgQQAZPCPp2zOUV6bmR6aDA1mfQ1B
BNXyV3irW+4C7nhuX10bmJwYp3QVphpgACCYS37m3/8E637pWM5542sjk2PipG3VdyyMsBHkGEsi
HFNbPnBrVy9X6f9wz1/bmhyUIAfVkdzBFm9xW2eV2kvh/PySoASooBQG4MXE64P2CKTOHeQ9Bg1t
pES0gwEx0eNlv4MvjI4FvBcSMojI4Gi/3XlXjqWSmyAsHEHAC+hd0Iu3ZINsDM0ocqLwYhuoor7+
LxaRc1EBPUf2fZruH1i3r1KoKpx8ku6Iu047q1s3e7oC8PAo6X8Zs6bdYWm17iQwfgd6ZXayNfrU
CRwmUAVIUegSS4KXBJ1vILfTL0fQu10uaDzEn+VKBTRVAqXZUnT7m42dvgLAFPSfcU/2CwtJ1EZJ
8QGY6cHEFfj6WunhTjHI09PzM7d/uXiGZ1xWfx/PNz9e33d2R4QKOnXHppPJyU4ap43ZLBivQ1hG
a2V8lkGZm4GZeb2nBofldk4BynWAEJPFUc+95n4xKv/X+uTYSw3vBxUP66+vsL4xuZA6tmy71sca
XXIvoLz19cRawrfNxhrXZierDVELrpJLmHXACqb+TdbQKx0FXB7P7ZxvvrYyWdLOz0TWLWCFlfXD
SELaETwjOW8hiJ3NIVzbmdyXSlnVTNTATrkGJWJKdu1zvZMiHdCq498FHyrOXc7Xxia3WliFFSNF
MCbuxkRZGxFh5Txpz98gGPtsjeDN0RGujw3fHUbcbGL5KeVGCuaM+hk0nCrCPCU/YAB19ZfL+vx1
Rqlh4eKVxlDxbk+j/IoqMAo8kjxxjZXTylKotv+EeO/vka0gSaUQ1RrpQLvVuBQn2xafeg4IdJaG
sUH+/AnBVQ4V4GKVGRXQlqUeGCq2/3r19zImtFwzoZfMulz+Lvq8eeeD5D8QDRIAHVMMjsC7UdrH
SAKVBn/Mth20cE6p5ZneW2GbpVUS13b+JJZA1/4B9Ip6qqNj2368We8r96Orv/qIyS4KujgNhwgf
IRyirYBe1ugl3oVnbZfDmmt6m/xpiVlx9C136wSMAkqOaHbDE+k2QspbpRCyfEBKN2syOvJCUQRS
2cIxnA33BE5gEYNBjQpsgLdmslZN0cOXQzjqHb2v9mC3ItAZOrBVxsLOmw3Er01NHAvfMoIcK6l4
AkJtsKW3xPYol1va50UJgMHkCVh2Lqrp6vIC89Fc/HRteOJrGhV8rMKQiadi6xs4fVRGv8CSQ7vH
wUEmCpcUD2yaxgIKNXmjFWXgA3qkDKeszInUvwXVSx9YuShZb10EZDJXEDFZKlnNDA0NUyh/A3+H
f06Ru0kn9kFTNexpo0lGaTl/wBqUHpYIumduohsrE78WiVXW8Hi3nQLp4n4xNW0g8jKYUfe3/1uB
rULxFqtM91cvTvvYigLSYknilcmJC+MmUgQ8R08Z1EacSDC14bX0UGpHt52b0KwpXoC1LkXqSGeP
NxfO+/2Ab61PBpxVed3lDdee2EYf0PyQV4LppD7JRDurRCorqyLkN2BkWrB7f4HAriqByUwAGSMr
TgKONuprtVdToJJ6M2rWjFKSIR0A2swMMdx7/aXQzMAFe1i3kSRIdmjKM5C8VpVSp/lb1Qv32Uwo
gM8BB+DYUAwY6+9dchXhiq7LK6FWdCflTykeh+KYD6uU+WwucgPWhRfcofVqiR1yxk3cGp3MgS8i
7uVEILMYtjJUrjSKmjTdNlegTRms+v6dqcASZKtp+53qfXBoObASMj4Zkq9e3FXJeWFNxgvx1hHf
fs/EQ7J50/rY/d1pyPU+2SghLsbUkBP0eh5d7qknfJDqizCp39jy3iw4asCegBTTtPNyiNo055q2
O7Fr3qWK+KyUneXyklVmn4H6IShmLsf7IAIl/4uGdsQu3WWlHQ620OyEiMb5U8e1pPJOQm/J4kH1
84XQahz3ow+crFPjoaOtZAEADFrhPdMYz/Jrb8Mk/LBwGu/6gAGMxTb8dyomK6CEvceAzbM7ucVr
6LwooHtGFhRt+GFmMvJJQe9grwtAPWEK4nWRU97ZMeVzwB2L6IXjTdb9WNgTc95JAYoP/RIohqNf
7fbWlPwhUwWX605a5KudkcRZSF0xFL+0Xh3MRMp/KkDDD4WUOwbLdRsmAEgSZeyvNlLjhSTkOM/T
dVDEsV0O2wT4vomnDDSmS4Jy6E5RmGC1pUS0VUjrLPiC+4tGEq+tTDwiesIiX4gwYuk9aK3G2bQc
YQXgWr+Y9n1hdud21pWtaRlADgohZkrYCpkt839Iu7YmOW2t+4uo4irgFfoy3cOMPZ7xJPYLZSc2
IEASNwn49d9ick7SreFrKj5JpfyQpDeStrb2da36S1D/mNOv5KvNksKJM8xa5+UdfeTjsz09zgZC
zg35711krBUJI7hFIC/BcOb16eZF0Dgz88aXHVCorHlXy30UtpF3og9T5AaH19vyVsLMa3naTWKE
+QWuwPjiHqv+GehIEmbuAH+aHdHBf1R303f8c1eAn2YCMU513G2V2VZaUa4/QVNoif0gnWePL4H5
pQo+9GYTIf2/5/QOXAyK3vvghFRW8WEo+13Lv5D+2wSGopmdkB8Bei1Ymn7wZk/qgzve9wJz+POn
mR3LznsMjPSuC1QsjI9d35x6NPcqV8XTRgF3xUVfVvA2FhAu5R1tBRiKJwD89QFslcdmnB6Xv9sT
nm38mcdjexjtY37eUJW19xodQ+h/xrSRiS7+a00RU+iVnm2MLyNgRtyd4A0Co2xC+ViJngLkY5of
hhn+9K9ozIXcxT5dPMxjk/XELcn40tlg0pG7AsN+nnBiN/3oV3Hplgdl/GaJYyYf0FGssjpCp0Nh
A0rO2+Xk97rkUeYBRhh2kt3zja9biSlwFD6a6tA8iNbUN1Sui6+rAli6WeIoWiCYk+LPSjwi4gad
r01PNnrxFRpjz2m19SCtNONC7oKTi25cFHz02a/KcJVHM5yGl8sDJYC0IcE9SRFeB2yXhoCJyKqd
U+2N9L4VmGp/EOIFBBhWsWAaY/58du59hLLk48QR//xCqOUtkzIWRl6RMMS03fWhSaJAvyEwTdKO
j5ghjETxCbo6Ak6glAyAAy+ZiNSUbAWvKzqKyBnz3IATWaJoLfqp/IZVQWfIl9l87SxUJcmx481h
ZPXeURs+wfIKaG8RZMFVRGcYMNfeESGEdaAyN5Av7vhBAAZHqlcM5RA7kcE9wNPcT7fvwUrMBW+Z
LIiEGMlG+KNZaukazJstR76g6YY/j2Nm7wXkHqAlsdmii93B8p8KHOaznSn/XDG2FamsPIyBF1rE
QdiHRKnusgu3quy2COXLpyAHws/gRiY/cuPPam7jaguqylmeAn2DMeGFYSF/gVzW20QrjO5hmoeo
l5JM7HF2PeNT5fcGjZoyw3ix0/PzOEDjHbH0JPcpEOuBcsymcNgX02wnxhw0PwziTPGUDjUmMACR
tlRJ4gEhz/1QBJ9LO3d2vg3ou9kvyZ1MBfAIQhgzzHT2e6cNvrVWJ44G0oQHQ1UFWqJ7NxowjnJw
zclrom5wYG88p5k3TPyaIsPmOXiK0H6OjOz1/Rlzs8mKulQvsmK/eXb/5BrfffUkm8fO+byhWCsO
XoCuTA9/ofXonWJVQQ84pZyrFzfdhygf8PQUYiKC5WAmUz9lxXddXf82dSqufSOa5ira+IAlGfLu
oNFluQyF+S5GWa8XK+SQzb7RoNHVPWAI+jg0+cHGqyyAAq/m+3Y+seJcG8CtcP8wh2c+AOe8IdE4
/c5o9vH2x2hKt6BGLykGD/YDjx325fpb2lrOg2/bddJhNsasPldb6Lb6i/EfCQ4GyT2A42PW7lrC
UFOrcZRfJxLkdTuARP8I7XY3l50TOSQuVeSYAUDxvd+5OZ3MNNiIMDTN+o94YPMj9IZ6vTVdXDxY
bBLzNLrwzOdKqCjN83Mj3bPPXmflHltz3OInWN/Qf+Rpvko2CwxhEwfL9T5T8UPKjVSbpjzv1qNt
Z2cPMycGfv9g/3R//7Lx68vXXajmX7+ODcdwAMBgA/0eekPvIp+G3RqNgxcg9jLvK75V/Vg9EpwE
uv5cEzkITeecbC4I9zOW1BP9vmDkztm4J91dZbs7/8/b+q2nHP5akecikAMbBXIdWnBjlUOm+qJi
iapkfkzdCcn5KZvv5mCSseUZaQzKTPIc9JhzyR1OD7RrngSlX2SAIbtWzG4ssyzbWSEN78q0r4K4
EUURh8MoN1R1dfMx3o6sMOanwLpzfVMAoN0OTV+yxJMeENCoOWBnTrf3Y10GJvtw7WGBQi2iHCvu
+m3NWGJlaYwZm5hD1khfb0tZVVJUT/8rRdv0sB+c2nYhRWTodj8W7uPcfg7+uC3k1lKQUDOXRN/F
zaaAop8qi7PE7899eCjUc083RNxaxyJCiwFMQlWZLbtVsv0ozsyFWxlL9u1/W4h+HzAxYmQ5pDTD
90l8lu3jsNW9trVXmjPlUcPxlVoWYj9hgDO0zpsTZKsiMJILmGfkdN/V5V3G0b2St2ApC9JHZ/JA
a2KYgPBp/uX83183eondgapkLvwl1+eeYb5/NtiAG+0CfHUsIpZbCAfSPd9CSNNc3jdJ8HaXyfdl
0t/ULqSJEq1p9bAdfo+UYHYAMlKQ/mlMf6iA3uX1twnsKbdVYe31uJSoXc8qmNQsupoloJCMyvA1
xbD9bQlba9KuZiCFamsDEgw13rXyYyNAYkfOTWBHXZu4/b6kX25LXDP3b9YGrjyYMoi2i1VGTYzB
456OZmJhxIrHVbBjX9305bactcuKfsNl8hTJu3cK6CjwzYoGCjgHd4J+qO4H4M+WG0LWDgiRqP02
z4SJPW37prqm9TC7sGz+D4e2kdwaO127RvBO4VMD5xNcVpoGdINFqC/wOI45q7/4VdOiJFHnCZXD
Jm+kVgp5029gczj+0heLsENbjA8E7d6YYRW8Ocwj/tQx84B+xL0J0grTepoxxN56P2rgXt8+qbU1
YnGoO7jIwMH1vL7BmGP3RZcr3Ktm2guax2Hxg84bla0VIYihADtvI8n+HoXdz6ka7XwsE9+ryHMr
svHgjM54Fr1MN2Y415wMOLhkadzBuBe45a4XJIp2UFkwlQl4oA5NXnxw8vEg7X43N8fRP6d8hKth
ImXvfLZHEvuhfCKApmcPgI8BPQDGn+ywANxnOmy0l63ciasPW9T54o0kSvZmGcoyAfj/lzyUUSEa
pG3oHd0Cw9K7MRZluhKlHWo/MT/3hqFMymE6MKA7YyZ6/jwgOeU4Hyw0S4gEI8Y7gjJtSfH8FLvb
SrW+1BAQ9AssPG7P9VK5J80qlTjvEpxSU/bTLs2IA0uv+v22nFW9Qtnsv3K0C1pKihEj9FkktZrS
Dz2whk9eMb10Ep1TvyAJ3WfgYcINRfrzekWBNxueEnOZOBnbgZshz9sIZLqH21L0ye+/Du5CjGYF
JEZTK2HbZULQSOcD/bMmgM1h6WG25PdSurABzb7s2weZuY8mV8jA9EfXHkVUmzNSokNsKv90+6NW
NxlXF2YcUTLR4RRaQubGV7hQhewj+4RJ/IhuQDasPEswecAmArgNCMz1DlLQQvMJyDu4s2ZQ3LUM
oFLe+Jm0zVNtAuo4GM0NBV0ViOYcOEeoPrwjRhlT1eSI3MokM37Lubcz54h/GUogc44/b+/eohha
FIepyn8kaVfR8eAbE2DBJNP0YlsvBlCsLeSRSJCEzoTMzsttcfrgwl8ahBoewgmCTLmeuaJlSAFO
YpSJouYcm01N955Q+a5yzCzuxyqNxgbFBStPRyBQVfLEZNbcuQJ8DXNefgcBDogIWhH8yv1BHzL6
ocAaFOqz7oGyR+mZ+KyOnZHSjhq0G9jD8+3Fr2rqhRB9rxcqQmtOISSCN+gmagsHYsWuuXB0UQFE
wyuyVpq7y4JKCmr5ZUKnNtwBpADEwJGViafcNKf97cUsz4GmOJAFLIIlEQcHW7OhLIX4UcC2ecz5
2rb9XT50H2+L0KmxFmWBjCWvCy8Kj6YWU1EuAWzBsGH93JwYqP9SiaCbRGFXxsxGhaN55eXrDMik
hlRfbHBZZOO488MKRSpk6VDxNvqtb1o5xKtv0iKwxva4IYOgTMLS+X0u5rsKkKNuXcQNEOzH59r2
ImbJnewf27aDMpvfqM2/urCVpVtsOBMrZuLqWzRfok+pPZmoZiRZXrkngl6ZyCxBX+kPIFapZqM+
jPWsjrdPZfXgkXZFNgYGF9T1108NK3KheoVDaQB/Gou8Q/RhmfO/t+queSFF22YzG1EiyUK4ZPkx
pB9Id2Lp6+2F6GWDv9TrQoa2farowioQ2L4ac/3wqWz4Xmb7M8h+pmYQt1MX575zZzRbsKOr1xR1
GLTU+Ojr0MfPysFuGYAzq8Q1j6Q+5/Jb/9ncwvtas7TYwX+kaOckeN7MsztXiVF4dmTYY7+vqqK8
a0VvVTuAxc0o54agilG0PYlhNB6R3Sr3hgEyT1B40xig80MEHOr033Uq/Gfb//kw7WirjmNQmdMq
6fbyo7Hxnq1ez4tVa2dKhm5KYQQrUB2ARtBDr874o/CfbmvO1gEuV+TCVVZu6XQtUOCTIcv2WeZH
w/SzA4VLGGzNjm5J0p4Mk/Vhzoy8SubxkNkP852c71rn34c/V5qyfMTFcvquVAPNoI/jcG4ysSPp
Kai2WhRXbRUCOJBsueg7DjTXsRwa5LpN7FlP09gbDjCXtPseAhiff7t9OqsG6h9JOsKVXfczDh9v
ueUDt3L4RAvyK8bpQoJ2tUiGvP1kwzjtmPloyY+cfL69hGUz3j2uFwK0K5LVktKeYrMs5cG6nmt0
+df+R2q+LI5J5gI6bSuCWD8fABz5C4urpWfaCbdSmk8dNE3WgNfu0uypq9NjFqZRDWMFL36gG6tc
vasg4HZRAlkKt9o2cphBKASiicb9Uob3HYYqPBAy3d5KnWzmL3NzIUXby5kE01iPBC+JyhN3BBDf
TrEqGoG0KuwRNX+3i4y5ex7ggKqgBZxR2UUlQ8wikccNa+CzeV6kvCx223HncLbrvR0bUuRahmff
Al/m7Q9e8chR6vBwR1BxRC+2titylK3dGfjeQqCs1007lf/hOOfK/L1/IP5WKLx6BmSpcAICyUGn
0/XdL3qKpQyLPx60DyaepWM/2HHjqnCjbLslaPn3F0YGfSBmX3P4TelUxJ7/5PeINLJpY/NW7/7F
cjRTlttwziqC5ZTmHaYVhg3fZ61CiW7kxfHBHACAaLRVGB0LQtpiFQ07Ww2LLXYq2RD3NUowL6wg
KLbvn322FQ+uLwv9t2hpQle5zv3Mq1p08DvLxLafQLf84MutGeZVrUOS7b8StARC5YMV0JV4A4YQ
8+QOqFUK82uR3RsChEdBnozuliO96PE7G3chUXsQJpYWYrJg46rcuBMkB8av3PsDWt1ssF3k4R1R
J2qBqyyvfuuarQzw7R0FSOe1OlLXrszSx3pbwk52X9/xZuNVXX26/14f0K6vJbS0g+s3Yn2NcsCm
nH0MCvdD75LIpc7utsnYWoxm4oZ8GMNy2coC9ZqHrbB169c1lwpzwECnHbFVzXncQkRav1D+0umO
3gLMUWq7JAuDq7nEp/MGWJRUHiUnu3xCX8Ns/V5wtCahkPrchsNz3uZJPngbqZ3VxQGcGTlVNHmi
eeX6lAJl+IZVcTijU9UB3UxUn1jTjt9vH5Deu/z2CKEzELlGdAhilZrdCO28dirKqgSZz3hGtXys
rd3sIWrM7JiLe3Ti9SD7cM+uein6GVyCJhjm87u+dKIS3WiT1Zxaah3GpkhUTr7d/ry1Tbj8Os1q
ip7VtBjxdWYHbkXwP4ry9baENYcG0Tz68UKAvwd6YccZfKcUjUCoVZ2yttvTogGa2hSB39z1Ec/L
O+bS3W2Zax7NpUzNpJUkYNzwlz3PvlHpAhhtiGvxkmI7y+7nbVmremxhJAENEWCue5fWl27VUt+C
++Q7r3VbJ3UTnng2fiklIMwZeXDl3mqz/ZiD1bfkW86bPoT8l35diF9O+OJ1DTjNa3ScYipNRq4f
lEeU7iM+NUfZmA99/ykz8t1IduYEJEVUiJjKQbCO5MEOE/f50B7mqjyE8L3mdI5dtkVzu/b2g/kR
Xv/ClmDrRRwr71Vee9gcazrw4rF+KbsN72I1lrccCMHqAB6jO/1lCTxhHiLa5Q2mkFOgDHefLI/H
dWZ+6gIrBkIrmJLj1JAbHsdaMQNl2H8kaxbMqrrUlrYJ46tmwJ9OUa4eWf9jFD+a8YfjzJHJ5qhv
7g24lVbq7rst4/L/rB3dYYDcthZAvuvDN+0s4NJv8XabIkajIw9YZBtmLKc5nu1i14f1Oevv22KL
ynf1hiEDhLEDwLEDf/VacF97SspMYdNTO6k9dnQ7Jx6Af+sH3bEBievtS7aqRhfiNCVHA0fVFvkI
jwEIzQpszPlTSLcKjltr0iw1sMuJxd0BaROnjZomfGitb1Z9rkNxsjAFe3tFq8IAe4PxtmW4k2gb
iOGlJpUBdMduwxi4va1HY2p+FUjkzcXGG7QlS9s9LhuAbSz5oAKo4x3iue77ZIDQDP3RbrPV5bzm
/AAP4e+FabsoyhFvyiIsr+XB8M9gLDiAvgDc5ZuV6eV+6X7kpSjt8XIKaWamYSOxQL7XLWYQ7PvU
M/YZ5fHkf4frKmkyBE0ihNzw8Fb1cQGmw8gsHPM3vIILozsbpCUhg9G1gjzu1c8Ww1VKbAhZfTkR
ndlABgXNjN4TGVQht/oBO2nlANPPzh2td6WEMU8PvXxBKjHqrS3C7NXTu5C5qNLFwnx0l5FSQWbY
nmr7K3OrqHLqI/jbPt3W/1VBy5gGwVSRhSmqa0HUnQIm+wZPdDVORz5JCTdIzLvOzEA0OPCNmGP1
wDBH/Z/ys94nnvdZ2/QK71CF1mTL/iyLFqD0T7fXpI+g/PUWo3kVPq0Ln1YHAycmlbwXsIoqrHZ9
0A2n1Ec51hNWXA9B1JHqc0tNHs1/0K46CrRTgAw2r8u7Gbw+U7BV2lrdY2CSozEelCDwUa73uO3N
ahhCaGk7PDYdKFYCPkSuO+8dCifg9trXNhjzUsjngIUc4bF2FzMv5QOA2+AFoeMUoqT8LDdv/GKo
9At/KURbENDe+64AX15CcrFr2blGT9ftZayZyksJmudoKarsPic4QV7F9vCnJY8E3Oo96ry2uZWy
WDsf2wVBPXAfAXyso7lMISLtDO4bmk943DB6FuN06vJHZ8BtuL2u1eNZkJCcwEeH89sE2sW9Fmgh
gRMQVElJaNzaO9ahu0r9j0K0N632+6nOCTbPCz8zCXSqYl/VW43xWyvRHjM3tZRfOH6VwKgHhhUT
9mBgJvz2dq0q2sV2LR9xsV2snNxUtNguU8XBXbPF6reWclka3cH5CJwA0EFc//w8UOqFs1ElkjQv
SK+Cfa78jMmR8wge+46LP7I83FjRqmKjVxuoneh0QofdtUhpS6N0EIsmRdEkHkFrjXMqBCqH6HRG
kvMXtg+T+5jURtEbz8m1MOG4adP1ZZ1YJibTJ9NXx4A6Ir4tZVUTQD2CwVeE74D3upYia4flxljX
SV6G4O6zGzd2yWDhPVbseFvU6k0F7zQMHHhdcHLXokaDhl5rsjoJlXsQ7mubZ4dxKCOfbiBVrK/p
b0F6Hb9Hx6qfclEnYsC0uxz3ofpcgvbxf1qOpwUuTd8hZpqbOvH8NFJ18L0NPoJmbl+TbH9b0tpF
WvC34CnZy9iO9syXE686l2R1kvUzOq6IO5R/YDJhS+HWtBvcxG+kP+j11betko47DASvj5rk/WTg
iQWt7Y98sD65LSrjdfp8e1lr+rBA1YegDwCTkN7KF6gaBEomr5OmbWMW/Fg4bjJQpjG15VKsbeCl
JM1ULMDeszK7OgGQHSBSphwd02HnPXUYvTxkZlDGYmr7k5uVEnMY4Y+BpFk8OKYRqyxMqNEQkHE4
2S/ch8uv0qyJUQCPcsQAYSKcVz/40zK/oZyX18Mv3PAFHB+XHCQfCJOur52tWJ2jORF2pBR70p+X
10QBJ/L2Ya5ZY+DeoE8XfV5LD/e1FFIFgTPacw1aKJDuBODmG/hXv2/OnW3sAUmbRYW1cS3W9Ad3
AtMCwDNaaGOuRbZe1jPUEeuED7MT5fIjRhtja6jMaBy2zOSWLM1MoqGsD7zcXbwM/3dW7IeK7jIk
BNJ03t3eyLVbiDQfuIzRsGODF/R6VfCcuGlMXp049phQD8h+1NiDW/pYVeQgqi3O7rX4aCFiR++u
D8Bp3dt2rdYVdY8m6KkOQYYwkMdu/N0Zwvvcu3fQAoT/6xyOZMNC65gob04+sChsgvknH7QN2uPm
5hWQC3OKfugcWSUwz6VF94EhSVAHztHxkLGdWVxz+mA26p7MaVSo7hfMTwi8QWBnYgQo1M2dPdFi
sv2CJeHUnFXj/1ZTJxYlKLqbrerQqvYgc42mZRwtWr6uzxQ6WXLLw3QDm6dkDNWjj+ZAOXkPwabv
vSIK1RhwzAdvtFA6GwbrGQnDCY3mAXsN2jluh3HXMMCcbA13rgpCJAhHCHPKmGK7XpNtCY81Pk6w
sR4wXvyR1T/ZdDaI/++DTg8gEpj3hsOFPIf2+HldUCIthikK1zBPGdoaa7M7+uOGLV5xGa6kaLeu
cce8CyQmJwTSVtR/KkAZT/kvuKxXUjQr4sx9LgD3wBIpjQ8SPZnEeLaNfikQsr4A0EG/YfvX7hkk
ugSdsG9vgHZKYlLKK8QyweOTAWw0VRyWT8R7nQhedLHnLY94JqPG/C1TWYQBndNta7a2r1AOpPQX
7KN3tK08ZIZU3MQ9d8dI1D8RaLh8I8WzJUMLNzuCyog9QEbtigilcSdwI6/+9gsLWWiOkAXAm6P3
dxRVhVqkAHgKtX+C8QgcMU8UaCa3hazdKRA1gz0IpXGUyDU7McwNQOR4xZO5cPlxmABUl9bOD2E2
H0BUsIV/sSrtjbEI6TfcLG3fBuqOXggI4cTP5lNr9xHYT54HJ98xtgXrtvKoeQsf0gJTDC4KX1N8
06tGs3AznuThZ7AczvWJkntf3TlbPKprumDjHVtgDBbOWM1aNKYtBEkNlpCG71nan5Effiil8+n2
QW2J0czFSMmC9FbypJsRKR19UHypjXmS5WZqaRqMUf+zEm3L7KAbmedQnigJYm75c2i2cNLWFwHY
JXBPLh3si35cxOdDl5vcH7AI0rxCAAFQpfx5e59WvItlFvxvEZpC+2MfzAUmYRMLA8hRMck2CvsZ
7Qn7shjv/dHdGY24N2ryelvuWvcmcr5vfL5oL0Jq6HptgsE57H2PJZy3zjEUtTiKwhmiIu0ZXpAA
pheO1nEEHdarcnyMIAs/Lhl19gH1Af3EOI1NMQ1bbvLancMoto+ub0w6otlc+65W5QroViyxm+no
hT6CkfkwOQ8cLAcbW7B25xxEVd7i1uGJXo7/4nhHS3YICHAVLOqdpqA5zOUJfM17X4Vx0McmSqmq
CO9AIxZnH8PeO6S+2k28+KiCMbbbZ+JuNUutqTSACfwF0wR4zzrBcjtJ2ICC84QB8D8KWjeLQeYp
N968NbW+lKJdnFYpm0sHOjeOHUAP69aL7TwsoyCdxGFjj5ff0i8p3lcMETrgNESm5nqPHc5twFUy
jmTQT7+xYoU2M1EsRUoFhGfnXoCPzL6fGBq9Q/9Emi1e+zV1Qm9e4GIKE4Mmb9NyF2csspqSmrUc
pcvzZJ/rr50QW9Tra/uJuM5HKAIOUFfPc0yKNXU/NDi1ztgVYIhs010+brTibwnRDs0ba0BH+FgI
R3sb/K9gAl+e9ytCkGzAU2SBS/ytCeFit0Iz7YBkM0JI/oScQNy0D0yq3W2dWDsS9MOgCRTVJuyX
ZnlCVc8cLo/AQH4Hlq/qQUj6w/YwkVj9iruADqmFMBy9ASgYXGtfR7OB9H0jEtp2R8qM75P9h1UX
97i8t9e0YkrwQoDNb5k6AiKUcy1oomZhdGXPk9DtwVEsjIPRZ+fAR2hB1c6rf7stbkUZrsRpTqvf
pzXyYB1PgmGKUv7NKlFn4ltAV2tSwJiyFJoCOHZ6+2w61o2Zpyb0Gj3BrO+O2V3hlRuv+Fp7A+hV
EfPhfACmpfdupGYOjR6FSDojOKrQ/Zhnn8VQPBCMr86d2HH+Da20MaNgvU3rI5pH4rLqNxR/xfBi
lQBBXqCJgQyjvToYpGBVMXQiCbg48bY9s2zDB1/REAz4ISeO1s7FGmkOEaoWQzXQSiRt50VN+pi7
xyxjkVPnUTpuPW0ry0GyGm4F6mQO+Hq15fgkY4FfTQKpEcuZd9D+5quX5wjZbuvh2qJQVQfcF+az
0HSmGSXlDuk8TzbsRdhXh7qx2QnoY/QgmQuOWoE5v2DO3Y3na2Vx8MVRYcLqwNYWaJe6Rt1PyTIQ
iVeJfTkPbtxR+xdG37F1Lo5qGY909AneHmyaRjiGAhMYYXDshVGeizw0zi4fu40bsLKJyymBzB4x
BhBYl2t4YXRZaw5I6qJeUuA/OIyedM5uA5w4MhPnwFgRRj7vnY+3T25tExc0ZwzcozgETO5roWMP
gK86ZU1Spe03I19a1MP0eFvGiv1A0z0G3pGpw+SjzuAJBkSzHXO3SfLuIQD0RhsKIFeI3b+XghxZ
8NZgiS4pTddLL6WM+7RNnDbf+/NnlIRbY/+/ydAuL81Gu3PAwpFU3InBMY14o9ywD2sHgs4BRLXw
lsAkvmjJhRb0crIBX1m0eBXpXTC3P2r6K0PcgJ7CTBja5HAmepDp9JbXDo4APLkkR5C97Kwm24PB
5O72br1/4LEIc8lyAw4Qba+abjHednPoIJYF7WnSul8JIMnbuo9kQf5HSfqmUVHhdc85Ri+effql
TjFjRz6UxpfbC3p/NlgQ7ACOBsHau7PpqE/6yZF43b9bU9RvheRbP6+lGQRwnbIBHlFilP7O83es
JBt3ZEuC5nK5DSmyfMAC1L6Lh9Pt3Xl/zRGqACQQ7hUeHaLD2KJhYeoFwee36dEPwaLdvwb5ho1c
leGhOQmlMCiW3sVtNgyJ4czHCbRPQfEKsFHT/nx7GWt7BBvytwjtLfPstsuakUBrgyli8hUAdLcF
vL8WQKGCwV2uBR5M/Vq4zMynyrV4UnYjKI2JOSStJVCVF4LGo6HmjXfyzaW4jr2uBWq3Q4DQeiSA
oklaGQfTUYhd91k2+zY7GOeCPVhyQxG2FqjpccaYO5qoVyaEp04cuE16GmvjCzPRmAoS13bDYi5K
+355QIHADDeYCN+QzS8sZp0aORucGcszHLVjPUatXPgBlmr3tvyzcfrdaHEjSie1YXWWfXsvGA0u
JtwrD+Pj16ZapnPhOymiJLTt1OJQs2xXFQ9pl8dF+XRbZ9bWuNQPQEy7DFDpvAsYHaMDs+FghX6b
gBwErsA5dekhqA92SiMe+KDn3nDq3l8ETBeCIh2vBB5tooOr8pI7cHLMLnGcH7370OUbrdQr23f1
+9r2MZv6qnTw+2oskHh4TCOafQDpQRlsbN6KPuKhw7bBA0GvmA4FgZQEqluz3cGp/1NVj9AFMEEA
fnfL215d0CKGIAJEnkML/uq68/x5TLskJ96dAF/m+DIYPJ4bea68jbrgsjma7uEJh6CF/wNzYpq3
wydEz7ZZ9HhbwcABWBug3zbpl9tatyrE960l77lgvWhCWm7MWeBCSIb94vRVDoeqe70tY0WzgRH8
jwzNpTIsYEoNWdUDUMaMg4qeGzS3jn29mwpzn4sfjgLXQG8Xv6LcAVDfwfG++Kaa8rXSTck01T3Q
Rz4x9qTUVs54VekQzTr4eWTyPM0IVgHHMB3v+sRsPlZjihzNuINFGm17f3sDV64p6sM+yrJLptB5
txLWmM6kxiEpAOEAiOVGnrq+CLcekUV5NYVDXw1iVlS+0QGlv1q90edpOLhDMrE5rsLqlefBg7Ss
gyr7iNTq0zTUn9yZnb3iSMqzFbwS+fX2St+rCtqu0N6zYMMi7tMNPd5HVDaJI4GdkrJ9js6CAzVA
/zDZKo1au6z2eYbSfJVbJ2+c6tNt6e8PFNKROAQnlIVckn67ewG3sG8CmWDgLpbhHFXmEc97JMhG
SPbejFwLWg784j2zZMDSLPVlUtI7Vh2UOCiM9mQPBtk60+X+Xp8pKu14uFBtBD44nPRrSV2RtkFH
pEp6RZsystGUdTYdFuwZgHPjYgaCZRjWaYzu8zYSYwYEZrPjx9v7+t7I4CMwTYOAF9EI6obXH1FY
NaE9NDip53QHRO3IoGNktO7GhV85PuRlF+LEhfwXJbZrMWOasslTgGMMQIz2scuWUckkF2xDzHsd
XWJ3oIyCEB3Bj7d8xsXhdaidVH7ZAlXQa8x74QzzQ25g1smR1bfed8aITGZ351bTMxrRnQ2HREek
R6IWMK2YzgHEHJrCfX2RYpZzMHLfSjwAF01uVKWgh6oeqj8V3ZX34fxpsmlkyjgdDl557j/hh45T
+iJ/Mve5TEGuUMRbGGzv9z1YxpiBsghcPWT+lw272JDaZh4minM7KcZO7KfWbP2nkFHZxF7ucQzm
CVR0NkziyqASwPUA5LMMTOCo9fKwHOxK9tVsJq4vIwejZ3UIwkQfXE4GCOSbcMcrfz/NdN+Sf2+O
UbS1kGUmSyIMU3rX680sWvGusqwEnCJhFJTES7qib15uX5qVXUUzEDq5ED4A21TPFTVVK9H/nmFX
wVZ/MiVpjYhjHC8aHATaClAEG0bp/S3FGwZ/EE1kC/aongdr6DwGvpjsBNOVNiD7CLC0vlet19YP
dORFsKHJKzELql9/4YWhwv+u/Mdb1DUo76wEfI11E7v+riORcHaDfUhPInysMYYz/msLfy1Tc0VM
mnot+OmsNzAMoT4OO+41MTDIb5/diokASiy0Er14QCkJ7GsNKRtEh8j0WYlfu7KNZ6+36rjiLUPc
UpUNj9GvO4FBQ/TzLstnjKABd3083P6I948MfG/rLacPDIh3uM5NmAXGaEh8hGHZR+SYgt0IzLOD
RVv/5M3FQQ1usXEt12QuPjhA2ZA/QTXueuFOaM4j4PWsZJyCZCL5w4QKYMSdsI1HbiZZSDcWubbT
6NZAwc9H+xwg7q4FVobTuT2wDBPG1B95jmFFoE3aNVosATt5x2gZG7wDlUG7ob0rlwWvAK4/Xle0
wej9ulabg6JhhM1Dl6CxD0bVf+N2HcY97eS08YivWAIAeOARx/wPemR1dPSwruFojqBaAL/pp15i
jL1s9gMBFhF8k9s6897TxKuG+inSLpgjeAeaWypDtBKAcEk6u/m3hrTyYButubF561KQKEZTJ+69
3peXeQWfwYEF7gjwtkf1JIa7UqitTvG1I0JWBD8EtUBhcNnWi2dJqZ6ryqdOElT1nJjO8NPNsz5u
0Em5YVXWJS2jwmi9RWlEczwEblpJy8pJ0sr7PirvefL6R0OmP24fzqoYvPpwPuCiAzPtekEoR6N8
WtUOGm1sAPiMWXhcsiV3ojHnjSTc8oRdu42gCQUOMLBcbCxJV+85Nz2jy8Cy4sn/4+y8euRWkiz8
iwjQm1eSZdoUW91q6Up6IWTpveev3489uztdrEIRumMFDEZRmcyMDHPinPQeYJSjVP9Utehk/QdF
EA7866+XRkcOryExtWSo66VVhiGHHZwHj934NUf6wmK4Td6ijbk8dnShOXEgMKldGuZq/0Q1jTQI
wnVIlJEzssrpa6yPyYZDumoExBWNlkXKwFw5pCKqOc9jgBG16US3qgrafoNZmtG/MQQ5OJd8EeJZ
j8RYHUoryMLpC7km+nR5RtwTzHn762+/DJ+ffqmC9JJCbrZajzijuBSlk/5oNk0m7hrL6KtjPxEC
2V1eSfHL35vj3In04uiMkFifn/Gu9Ws43ULjMTUWkUaj/6iG5lH/e6oOcDf/CT6WadE38bJ3vmHu
qgES6sh4DIXqcbECCdtfl28Q2SaHpVtKxZJuz/lKrDTTi1QIjMe+jT6RtPh0+YxfVWpuTeJdPg+L
IVhr34qUOO1zQ2pM+9c3E4Om4rcmEV6L/FuTqftI2ioQXDOk0c/mZVBNxJ6Xt/jdptVDJ/plCIWz
XlhOgKpvHTDWLsLsvPV5blui7XxuaQCiKXYinwfarJ3cflPM0h062DDNrbf1MmAhUPn/NVnrbkPY
VhYJKZYU/yQVtQcXUyk0nhRUJKkb1dDrq8IpyACAOXSrEzFUXOO5Yv/kOAqdPJDDfV1GH4qsyB9y
s9m4uFccEeAycBagTIH5rFfWQdzeZeJA1BDSmbcFKfhsgHT+efu+XrWydMqIM4nA1lPXUSJrfi5X
MsxEcVnZuSLXB4ng7/dtM8vWnL9H0MS/wbbZPmLL1RmvSqkNygyC+NZIUze2GNtJBVFxKl0ad7dN
XV0RIyBQrzAHAtb+/OwVkSzlQ9MS2alR78AR3MP/YZgbHY3rVnQOMu4BB7787+/uErS7s2mGPVQX
cWa9MGEZ7/U8NN3ba7k43TD34rQZYEO+jn+v7pEwQMQXQHr02GWBXfvqS0O/sVF4zg31o1I0G1t3
EYxjDkQUUQP/f7zRynmrYRM2dVG3j2m616rjtyk5oNSoOIO6i9K/DYqxRXKMjADDEEREy4l5t4Fa
Mbfj5Lcd7GyCneLrrNxyEIsMtjzExZcCrL/wIKOGDd6PeedzQ/4IcjSW5O6x7frPsO1nFMwEZWM1
b77z7IAvVpZ4GNYZAvD1Ae/kqSyCrpkf64UT2NGVKQ1guOjVHyk06a2LlEqueKNg9ulDHMfdi6WE
pnVIej01ToVfqBoYUsWcbWKrsHMbddR/KW2plTtfM6JvJtzcr4UvSpUN1AXU8dh0qqcMQ9K5lSBV
L1mdJ2gClIX1uRhD5U8xFdVPrZXnpzQ2k9c8kevntJ2EXRr4WUyyrpQfe4iuqbEpgPTdcu6Gl5gC
8dOQxXPL2IgldLueWvVPOS+SH9nkR6+xH6a5reVl8ewns5o65azpJwVIf7gDDh1ynyFl+RImiyyZ
3w8iDZZwmPby3PTWAdBpqu2zvkiiV7XIw8JWUms61WotqPswkgWGnTXlh+7HYmuH4GjEk1RF6XOf
ITbh5ZFADj6LE6x6YeXT7UizQXgNxCj5Mht98W0wGuMuFqvpCzcqSW2RdlzhKDnydHmcMsvaZEUv
uYJfoFCX9l33MaBMIu5HU4klN9OkKnbaNiehScO2yeyqk/VPzayM3a7JUXuzcTXW9zAqtOTYjVNs
UaKbhedejJkG76KqLVyrCSWUUKoYosy514avUR4U813H3um21g9KezeNQbZF9f2WQK4OH+18ipmo
V1LYWivDRXIcNvIwDo+6JOVoRkw9ObNa6EO4F2drSF0fseGXroYZys5SK/rYFq0RsSFKrtp9V/Ap
pMrqGxQnpey7X6YjQKYklgF2x2y6JuV1zK5QynNldMr6XSqaGnOmepQZwGuM9kT4ImZg4hl+cnyF
ENOBZVY8UQrNdohhVT9Bn9WVa0lz+1tApiRx896EZtkcQHTtJBQGH4bSQsg5yjLhyIxZ1u2Npq/H
Q2vVHVLOjKzkNsAs42VsBlF0mSoM0l0/zlMR2FqDfprdVYoROXlNXWojFLx4+LnVyxQL7z41A+La
cxcST30Z5jr170EvlxEJXQn3PaKJ6ZZG0SXCEvwzI05Mh9GQokO5ykRNIe9HyEcpgceB9AKrzGhb
yEbsp7gU0ZSGmyfqRlAtVW6KjiHgKTrfEPaFAcSY9DbYDWoVbzGKXfGg5tJU4SEi8QJ1cb581E8S
vVWz8ZFEZeLpEWDV0vU/f/vUMc3L9qLrRqfxoio/dl1TdJE6P5I+75leg2+7ve8aPYO67LcFidff
m6NmSYJCFXrR5Tlf0zzrvVrMgfhYgHh96pZGvVFyeDOA/UR0s+Eo0ShuvK+X54gnaJkbAgwJSdb6
kUBz1RiaUZihc42tHaon2ZH3trtHHLegkKltcZcsb+i5X1js8cmI+MmS1lDnvhkLPmooPoZxZDhB
oJYnqxd6V5t6YSMeWkUqUJYghkGlBkPsKuns+X5G4PmzkDTzhA7QYLqC58nTP0W5sYFXrbAakEVk
MITG51ZqI5m1sBb1k6gFBa+PEN0nca3usqJDggjcidN05uvtk7LaxGVlcBXS/l6IKenBrRLoSYnN
0vcjXukG/ny/8Us3RvnSzkiiN+pqq/jrzZSEmwFFsgDU1/CsWix1vYYW9JRAAVamynMdNc6QFR5F
2f2imFKnupu27UbjYHUs/2N2gf9RV+ForusqZcgwOLRMOsrPr1P9IRx/psGpGbfAKldX987M8jPe
RXyykKcoFJgEDHGxL5rytzRLtpJ3T/Gger4YgybX3WHrYG4tbuVRGS7OYVoy9JNk2clxNE4QkIUb
LPZXjiXpIJ0zasnMlrxJ9L5bWQ9rYmUsgVxVD8ZBDvXgIRzL6i5N88w1hbLdmQhXbXiwa+fyvdHV
XWjDWTfCJDBOvaqLLvUyYse++BJUfru7fQPWvbr/HJClFrI09XFDqyuQtz592YRzmVvfI99/Mawj
qCQH2txjLj8k9X0fHsNy67xcXeA7q6tspCp7LRuX2wDDBdmRA9yaAtlGTr962/53aQtegC+3FM7P
D2Up6UIYZESxeuZK8zaxz/VF/PfvXx16vVT1Zur5+0sKbmn7GkifCXDt2x9oy8jqjMtp3eRCt9ys
UXJrQ7f9WKN+6f4LKwuPAz4QvNk6sab3owtUjnC+FlIHTTVJTpflv+izbimaXv0oUCEtsyw47TXA
OujLsZKF0DjFWpocdSmu4DIQpP3t9VyzQoEARCJlFqD1Sw393a01K7FOLKDEpyGXijtzkEqXzli8
cU1Xlfi3A2ZSvVmK8LTP1kWjRCdFCv3WPOUi9PE1czoLNMe0R8Fq7umvzvZQVD/S0NhCN10zbFFz
4dbyIF9IDmYG4ClBHM2TPwCjU/VM30t+kblGEM27kaLjUWrl5qAlebG7vbFrjMOyZmIrBiUICZZ8
eLWzijIAoBUG86SVi8R82Ib7LBqOM1WfPPo2WvEukY4qxIy9dt/7nUNMYZs6XAXqBP9vcQzN5p66
7CESo3ujkeyKVPNf/EQwQvRIiFfAh65i2iBL49KIBO59m8a/h6AoAQKKvmvKfvWkCiotXpSwXMCK
6qHU58dq1lU3NivIZH1JcM1QQbYCRYanhSkAsmrV/BRbg+4Eul65nST8QG0neYlEYdg4tVdeUeCE
DO4z7wqGZD0YUHalaqYTXtGYJSee0APL3aL/JxTv5uJnW32QtK+3t+rKNVnm3El7oFMC2bWKlKdo
otPi58Zp0qgISKnxzYfsdcO3vM3nvwtV346MwlV/a1hxbFZ+0qj6ooDZXT+lU3UqrF1mPETyqc2g
gk9mO7DC/TxRGvidLyls+BT0HsWjh0D3FL/0KPjtI3N4aIRjXtsJ3KnmawdLm/xYNG5u7ZIwiuxe
rzfiJuPKFWNTCKwJsskj1vNwglo2jY9XPIkzfLR2ntb+R0mvLWi79TZzRqCzB7kz+syNM5ULrjK7
i7JZlU9/aN33nV0x8zzvJXGMMjsMq+KrXy+CjobsL1V5I2VGSx0EyQ6NBFVIORMqL9Sy9uc4I/Jn
50MSKa5EJeZn3FE2cmUlykWnIQ5v3D7y+9qFXrpLd4KWZINL6b/LHKWOE9EN88n6plXURZHZyKqT
b1plQj/AlxlVTbW027WlPKduaE3NPTGj/2KWqfRFDRNftJnFnmREEhOpw5f5Apo3qZTETp5k1iE1
B/WfYFbqgUqVVn9qw0yM7bpv8n9So1UhZmiK4FQCSILCAz2yxC2HWvkEa7AQOIIV8Tg22dR0Lmwf
aXCv94bSOHU9IEekdYUeHbKg1kvwk033TexBRuyENirUg65N1bcCZrivetBn+Z4tgvcKDYF5OAaA
rxVEsGTKaalS5h9FMDjGxiP8htx6f4SR3l5YG4HC0KLEcyvn74lQz7RWcSxePS4VND0J6tT2G1Mr
HVmOpUXDbu5cpRUKwHOCrrlqaKUfDEEGExTO1vRQVH7uiLMp75WeajxECdLwy6rT4DMIguYvY1a4
MiyQtYgYLrkhA9HnvzZqkGOcG0E7jZFYHuCVte6kcoxdq+j9hwjmpp0fin8bKP/HKJghgErUYtcJ
qVhLkVgwW3SaqKF9NgvVnQv4oPZtpGy8QeuQaLFkUVFYSst8jbU/qcWQYo5SktNYiu2H+mer6u4Q
r9lIe5ddOv/mi2skb4ILCSjhGvSfRaVaipmonWRhaaO5sq875nBQlGbDQa7RVnRmmMLmg4GZo2V8
MaGX5qU/932rnab419g0T0pcHYYecFlmt732RBXzIObPbWJ9T4YtJPb6zVnm3ADWAo3grLDSVSSu
VVBTzj6Rnz+1h1CO97XClHGu3TPLZ0sQ5zI1pm9RvV3Z2jOjq+sEb5aepHStTkr4PUw/CaGj0XW7
/bZdnhICwDeEubrEgGvAcGrpTRLz8p26KrbDNnZroXEC2H1um7kIiNjApeUJagzeAZAsqw1E69GX
5FoyaVHm5iFtTNEbgAwxYilLe7lrZTdI9cCRx6q5i2n3fWn0pqQKZn1JDLl7mLJBOk0+kRJwvnIP
OkUBaoxEktAm8Z3aZzU017m+96Uw3Dh3a7WK5dyBFyISh52Oxr6xyi2iuSsURlv8U5QGtpLMuR0K
2ac+EPeij2b7oVIfrNpwRKOxA1+AbrHe5SVTWWLnlJmrCR8NgEF1INl1mDoovW/8vjUpFL+PHIGB
3OVagKxfY3faOgnEQJvo/kq/Qz5iXO2l5jnZqVWAIte8q4fU1hXeNql5LOqtL6te3P8lAgTEgfol
wklroKAMQ5mkNKl/ynrNsotIEO3Q1zcisKtrBOwAYfNyB801VESQQqOsA404Y6j+KEa5s2L56P8W
fEcRTpHfvGrBsNfAfsd95qCb/nr7+F7ekkVRl/kivABzyOtWXVjI41ARyp5MNbcDMduLYew29ZYq
3JaZ1Yuk6H4YmP0knOSIyU3tIJS/JMqWt9dyUcvgvDDtwbDMghog2ly5lSbVYcb0LeGEctNBHnq7
hylw8B1f+1r3YM2RcHDAdTopLNkbpi/d6BvGA6FMQKVQT6zSoixuhV7O48DzpUNdGq6gGkesa/oH
X2qdyUdyQ9F+pEr/UejaD12m/oTGrG0hABPGeznXHSv+QB/WnF5u/7CL4HvZEz7xMrbB5lzMTYRp
CAi6ygKvR+AMQj8kVRU98qpin2p3hmFP1IyD/CWToSRL960VI4/5oi4zFr3pStlRqumAxZ/iYmdZ
tJn2cpzvyvEYx72tm7UTlfdmo270ZK5tJk/uwk3CXoLlPI9fir6NFV8u+c3CfhItZvDNAUhTVOyK
2HBMka0DYC8wPrHhzC/fJfIUCFHAnQDoxOmcGw7DWNVmuQ08K5K9wRjsyag8WOt2SRbe3f4wl6aW
iBICJ6pgy0jP4n3eVShSyQikNOwTr/JN022NeN+o0rwL8m9TPe//2tYC+ZV54hnapWKxskXlQlpU
GryqRPhHieRjkPv3vqQ7qpZtHLjLb6ed2VrVEw05LSuGEVJvnhB51k1/gOx+ci21MfeAKL7Egjrv
QzGJ7gIxbo7/YqELE8YCLAVZvHIzlc9xonKRekL8KAZ7pohREnGtblN0dVnFeWwIwGEplr0NtYCu
Od9Rqtk1NKRx5pGbOV0AjLr+VKp/KDzs5uQL+sz2EB6qXHC1wtgISy+fJdClS/REkEtOLa7iDcVE
PNtqg8wDI9x+TCtVesi0RHm+vZPr9JeExyLk5WGC4B885uomVLPvQ5uTZJ7W+9E9clS+E/ZG6Wrm
yDDgEIrKp4w6YmCPde1vHNdrtgmGyecU0H80n843N/XhYRyFJvP8BZ4Z70S1SpxQiJ1+oGIgK8+l
Un75++XqdNBhWUXuDwzduclK6mTB6pTMC6Awj2bOrHIw4i/sMxpSrZP0n2/bW3cVlu1lnEOHMIP7
D3rz3J4pT0WujFrm5X2siJQ9hjAQ3LIYh/xDPRaxfIDwcK6P8Gwk5q/btq8dIB1gDpgWTi8VxHPb
LSzdVdPMmTdnU2jPU9s6ZFtb7e5rVuircTVI94ktFj/xzr/JQlIEAvmTl6AQg28TpSerlDZHjZbT
vr6IxPaggNhHg7fi3EyQDWKWwMPk0Vm0DW3RZzlMaX8UNcUJGdsQtGDX6jaqWR8FvzulUGjf3s0r
QTRMRUw1E6TSP78IOkSDFoOlTZkXBXJhi0zT7Ssj80Qj+y5rnb/vRhB+SYEamT62vpOr83ejao9x
LU57v2n0Q96mryNXzUlIxoDVSoETtHK3M5Q3pOi/eXkWjtVlKpZpIqAl51uGsmweJQk/uLWEvZ5E
TyMvfFN/qP1w4yJfewvA0HGNVehOGD9bWRKtxKrUZWvqvS7dw1y1i4b7OD/ku2JrOmLxuOuDgCbW
gjDQoVFcN3vgA4NaVewzT+785LPZWT5TZtr4YUgtlZOnbQ2aXbvBZMvcYUtcWGtXMYrRKVauZ9wi
Mf1twdondm7GYz5AWbWFAVKurg3qAdI1clkA2Of7qIdGXqnIvHtRJJTPSR8OD3IgiUeNeVv6/yBu
+rYoHDET6p2VCXjptMtdEHPxIdbrYq8omfVIpB87Ayhyxxii3k2DWniG2J7BPKkxj5PVMuOFuPVD
oFXJgfbtU1CVwk6N8/IwxErAZOqg23Jb9b9VM5xIT9FMKcS6sksKgnfQ5pDoMgO3p6rnH4MoaTfe
9muvAiU4AO/4E0LZJcV451D6NBpySoq51wnzb4L/11BccFvJnjvkqE2A8oQS/nU8uMxOgl2hogUb
77o+ngmmL9djnXuRJT3UkM7MApDd/GS0X297kcvThAfDH5NrMgZxQQOatG0k5APvQUHQJLb7DOn2
FueRzMZT1s+vt61d3kse9QVLRpmOsoW5Ok/+TE5p6WXuKfrP3jhWlZNkcAMNf9QgfWDa6UVVP922
uFZnJpXHJNN2gB8A1jISdv71grGNBlGqS08L+wVv101tYSdCZP1qw4IuQCFxbICXWXXhUHNoBxv9
JuFJCcfiHzEptE+yUUEIY/SAGWHf0KFILcVEuZvbXP6KGFH50Qq16nsAiqR3xSwLRnvSSu1bo4/+
XjWLYGNB1z4Y8zAihZMFr7J+3vogr1IhGXJPaNF9LKHy15jRbqbXxBwcrYubjZN47ZORxdHrYwv5
x8rdjGHQJKReBWAK/Q5gpX4K8mmfwvMDNeDRUpJ9x59vf7TLG4fThEsRwTqm/blz599s6nV5MKcg
9/QutUtrn+vfKrO4B5bQhOHOIpm+be9KHRSDYOIRgAA6fEEpZ2aA/YPKyrxQRIzW7qvG/5JF7XQf
DKX/SReBJzqZkpgfQ2gSdWK0lHLo2Bdh5YYaY7D/Zv3QZ3FBVAKmdTY4z6lFnb/KeVKSxFFjuoRh
3ivu2Cc5LUSreA7UDIExn0nj2ztxWS5hI5jrEXE9FKDWlju6JKKYcEFNmId7HarF5KCE4l+n2Wwz
kSiNKLbuAifnS2M3Nv6Ue4N0HFBRSeOXnlbPUMyOIQ4HEFk7yhp/CcpYHAFhPbg8CE2Wo3x+qGQr
6VMR0QQAzhpVkieyY/fvNw/yVMY/CcqW2ua5hSpHyz6wityrk/1QEPslp3Sz9X/t/isg8N5IgoEt
roLo0PAloJNZ7gXV7CQR7C/Cy+h/9EEiBfPL7QVdPv+QmfLwsW8ca2L28wW1wVgp06iwZUq6m3uV
ALcD/DzDr9R8u23qSgmN6hllFwb4qaBxD89tVRH6MiGDcV4iFA9+8FEsP4mqDRsywhb3+ffJ/NZY
9e620eWDnIdu2IRomZNhLcM3K5tZLzdUSgpsZoO/bwwNqsxBrDaC0etLY7KQK8XQPjH7+dKmfmyY
KmkKTwpLJ6noGn8I88rxp9f8aIilW5qanWxFENdusr7Ud2iLLc/t8m3fRy1KmxizbBaeajyU2Wuq
3dfiVjXimp9+b2P1NlDHyfuwtwqviSF0CO/m8pBPdtAj14BM61ZF8drJf29t+TXvVtTMem0odVB6
lpbuukR2cqO0lfJz3LRHTdnSTLh2NpYhx4UMmUdoLZ4mDqinMa1LHUIDLBK3xHlmYG514K7cMGic
IGRkyGzhWlqtKR2lCsWqpPQCPc93zWwolW34nXyYxiyCBUbd4uW/sizWRHYMfxQcGWtF3dmCgjZP
u9ITijLcB/S90c+TlY1n5IoVHi5QUOQNjGyvL/NomlE8mX3tqaPsP/WdvoAVBcO9fX2vNMd1msyQ
2BOZ02hb81QJhoLCQDXWXp5QlR1eyzFk8udVrQcS3BL6pdhtlelu+e8wRo9SXxqN7SFQka5GNpZS
vuuH6kaZ7A1IduZVqDJSzaHex49ClWX1Tck7e61hzV5vMLicTkkUO2Xc048bJrU4tpUSiU5HWyB2
lSgR3D7W9IOqFOrkSl1WaTacNcZ3CG5hjpl8+b4PqlZmHEGqG2eKJ/U5RkOYaZvaCne+OBTGTm3D
YWRMpgGuOWlVO9o9w2W/hE5W4frz41Z3aHwOv+POHMd9qvtD91Lkejsc67JGAL6qkqaxjQGlyF1g
9EvlMvcT/hhMOniKUt5Su7hsPi17tIzTkZ1D07KGNciJVQ5WGepEsZVyp2flnS9mVL2bQbzLQTU6
xtwakx2FzKDYTR0o+x4WCYe5kwg2tyrdoH++DAB5teHDYByOwhj/vQoO4iokFwV14/GZWrtIlbsi
a13FOkip4hpycJ/OEmzU8yFI4ud58DcCogtn/WaeYhfpJYjYNWlYlKeS2Rmp7g1NsM8rXSJPiZzQ
L6KNSPfCYy+GqBpwNJfO23rqoqriLu7nUveQ8AYMk9kTnOuUA+0aCpCpfRz8jTu6YXDNzmtVlgLM
q9C9ebbsTqKZU54MWL0lTWUa6Ldgfd7wCUtMsrp9POggsIGc89iuu++RaSAGL3L7AIb3O9LD4kGJ
1D9zF/R7hglUZNaKWX1tKi089rlS7Mth0A+CJlb/4puC2uaj0pvHzupIZVmo9kkxASarJbdjUk3a
Uazb+J7XDg4FAoppdKvJGFahBQFaprcj29sCbGzocNITx+9vuPMtK8r5y5tZlGwCP8dKc99S1DQQ
Yt+a7r48KBx9CuE0Cql38MdzG6qRhsD1VMXzk8xN1b0sHf3krqxTR0k/S5G5cS7fOjLn54SbxnjJ
wmfCbViXCEOxjXLU0FWPECpzwAHPZelMmrjLomc5+TCpX0X5s0iJWlRzp6VuVffTXp/FU6DGOyXd
ejGvLf/dz1mPDrV6MCpBw89RlEdkTd1Cf2ytz628H+OHIX/euCRLYLta/KKhDIxg4Thnt883m7Of
xIYmGF7WivrjmOSGHaATvfeJ5vagTWtPzgLeAp6U514rEYIw/C2SnosYYeFwJ/mj78nCQVad/wZZ
QU91GZHxUt5HXTfcJPtye5nXLCxzwETB8DnQVTq3YMaqEVtzY3qlKKho1yiFK6bllpb5lS9HiQIY
NvWYhUh9tY6maLpiZq+9ohv2gvIbAPCjEJ3UOzlKXdL0v3YrVETooADcAOp2MczXR0KyiOyybaZ4
r8mU0HNtdJjL3CLOu7z0dPnIj/hPkLNgaM93L5eTUpLDxvBExE5zqCXpz0fPkm9t3MSLEHjpJr6z
s774ckOjQsQOgvC2mYYktZ8BI+/K4e8f+cUSkBOaD/zpLSh5l0BEHHGzlybDy3EKe7NrFFsMgtTu
wCK7fuoLd307+0dJijR38Edh33W5hvuBGPH2wXwbXFvdP6QuFg4dDV0pODrO91aMWwCugY+U5CTY
EGk6WfY5lJnFVF/92GurgzG7VTk+xVr+sRzHV/qDC+AVlrCNX3JR3Vsmw3gsl9ADJ7geitCDCkRs
I1seOQr9ZClv7qoU2bFJyZMdgXdvw3Qs7as2MO78SZbubm/ENfOQ2KG5wRdRKDOc70OoV8ws5pgX
BktzKTW6pUEYmEOHARXM3cwUvw57l6BtLPsilXzDVeECKWwuCLSV/2M+UtRihEC87vvCf4mI3MOo
2tlGxenq6tjT/7OyejYjLn8ULFbEZ9HpP3SfekTRd9ZvZJBub+NyFVfHCZjYfw0tjvDdwZZGmUna
GUNKYVMq/Jz+vv33X24XzQHSYAoYQGwBAJz//TEPM+MeWuep05MffdEoSkbzbzO/87WN5OlyyxA7
xesz0AqgiQnpc0v+JCRaN9ejN1uFIwmd3SWjI/j/UGKtBpXap+Do4laJ+9IDYXRBbkGcBMesvPyo
d9s3DUo4aIE8epL2Al6M6ONkpB+Yzd74TFe2kVx4sUVrB87O1eKaTmwmMTRGD7YxLrlkd2bujBXQ
fOmjFFUbFbU3J3J+KiBXXdBoFDzpT6/b7dYY+gmtisnrXbzpV7OyR/izCqdS7U61E90RnN4+fP30
sfunPgj36TdQ+O0h2ofoUP4ef5fP5X3ubGV+l0eVH8VBYhybOt9FWaUMxK7xh3jyGFB6HEB0lMJ0
gDn+X2w1tUvmeVQ6JRf53GjGtUBrcvKaJqEy8CEMwe4jTVA7Zbm1pCvJI7JF74ytXrDOZABDH/PJ
M+aQ4+mIRe1aYnBSUhRf1e9189gL5WNRHiNhY5nXdpOgA13iJfoglDs/uaIgqr2ftJMX6neRIdzl
CYKp8QbE8NqxfW9kdfsRb2OGGAoMj+rtwVChshimh+4xCHezsPXdrlzFhZsSOgCIMpn7XoVsI3ON
FjS6s6fEgF6jr0ojO6L4w1A2go7LmixsVbQCOB1Q1JI7rV7g2uDe5Xo3e0LNeIRxML/ADwIVRUGM
77bpLk834rYrJY9zi6tvlQxyAu8lFo1u3ptq8dJ9mNH4c6hHFZKLmsBolsd8tOV+w/JbErhyBOAS
IChh0hBi3HWSyCxOF4nyMHtfvpwie396fijsb0+R/WTZMJLYkX0aXUJ8O3QqJ9jdJbtk+YMd7n/8
qOzGlmxmpXYfXv55fC2+OKbd77769qfQnmzZrg8k0IdwR13bjlzZfj5y3VzD/bizXw6Pj/d/nh9C
+8+vP7ffo7f5xlsrUs7PfW2Zo9EMrEizC/tp//AAI+Vu2gEgdqx9c5ofgLk8WTv/UXetb81je9Cg
tX5qn53jYN8DfbePir3x2F//vu92efUIow406nqw/KYnP18ISg4Zpaw9tX09+V4/A8tr5petEGP5
S1cbYVFqXIZa4RG4iN+SWBimSkpFL46piUfCLim3hIne7tzaBmR1zDEDy2NMZLUwxkzFxNcK0ZPs
wvmBkCv/jN3ISe1/Pn0PbdH21JeN73vFDTAZ+F+Ti9979yJnkdrPg4VJVfmqO8kxdQWntTPn9cty
YL9FnMlmn31R2GLP+WN6yh14PVvfdbbsinsJcH5h87bI+6/DFm/JlQjl7KetnL00xUlkSPw0MVV2
mlCS9mkIt9ZtQ5wC/c0UeUpT7ExV3HDDV/cEWDIcHzAxA1I+3xOJrr80KbXoGX33oS+OeXbXmD8S
tft6e/MvF8iYLbPlcD3jHuE6O7cD7LKeaohiPLF3kTGwyt7OSk8R3EnunVxSdsYWKd0VZ8wss4IE
GjSCtLzXFBUZrE+tlOiSZ1WuOmd23EiOHP8Z0oxS04Pe3Sf9cBdE2YfbK73ycC8z1MzoUIUmeV9D
oRWtM8mbNcnLHwXzOKsSBflpN04/e9tiArbNP1Z6vpOM3W27lw/qYpb4B8AYzbl1ay5OO3x1Z0pe
3JB5JA+J8K3tWzt6ioSNCshlbeLc0iri7Eu5leLR4FtC79N9F4NXWfycV4kb3vsozN1e1vXPiCbF
IuJIXWlNgS72RhtpMetqpt38ZBEp+MwqaoNdx5Jd5r5dSb8CntnbZq+tkf2iQU3rGDWD1Roja+gD
Tc1lzzSY6bT2YfvBkBzFd7rouyBubOi1NXJEGe5fpMDQfFl5phpmsDk2C9nLmMAcBjeCE4uhSlSD
M17S6iT0iY3w4sYaL+8+Pp49hRFUxs+vK1llG+qw1qeyV4kncKZd0uzy6TXoho148speLhQ4LI+I
iK7xyrlVfqpElV7L3lg2jll8DyXDjqMS9B0O39KQs9kw+FbWPX9clpX91+Lq66X52M+a0fD1EDeC
YC0sCsS3vgCsgU6vGqtDL7hqY6ETZNhU+mwhtJgVcQv+2I4/G6168K1Dm9lD1TgJx6yJjEMe6IdU
NhxNYchlC1p69QSA8sRdIDZIMrzs4bu3qYgzudO7SvYQeY19qgdx7eZ7AOlStQ9gzPINxvz9jQNw
zVURqVoLFANXCTTq3Go4SSWolp5zF2q//CB1RivaiYpbkiOLv0hebYuRyQ56K+YDjrdv2GWQsTAv
cNppjy0KF6sVIxo4zF3dyQTlpgaFUFPsZz/d4ki+8u7A20iAuugyUbNdvTtDXc1mFvqchDj/6I+z
V82KU0SdK+g51Agin1OhGr5FT3ltZ+FiYgxuGbrlc65Wp4f1UAtUyr2i/zkKzoCFSXBTzVaIik07
QqP1dyPI7u09vWp24Zt6u2YghuTVB+0ruWwgKfSWGe2p3jfC5I4Qk5njnS59KZPyky78D2fXtRy5
DWW/iFXM4RVMnVtZGr2gRqMRcwYY8PV7KG+tJXaXWF6HscsuDYh8ce8JgZoc5IytRKrXpvNry4vg
uQKFIrOyyDhVY9OC/z8gcmGyWFmx16YT1wCUQhTELMArf++flidaCWlH45RSVOAzEPfZx9RspUp3
o773h1to3oYrY3pZ1kBsBDgFno+I0YDq+d6mLAxUibFlT1FHZJ9N9+os7Z6GQ/Uo51YwiIwoKzHE
5WDi8Yhgbk7HAyey1ESfoIIgCTsTp1xNNXhpJua2k6x2+3PPrrUCLApCI5gaXO7AKdaFVsW1OKkC
8f2UKCpekKYZ/D9agfYs0iazj+rnkv1ysrVUzqD32YiTKYkisBOIddmjlqycJpd32Uwg+reVxcKv
CscE2AXvpL7Px4OVRKk/JRTRvWpLW4fqw8rYXWkP9yZSTkCJgJK4BMyOjlBzmmXKiaaa+VoZzhQo
vY3wwKAxLKWFma5s7cukDOJY5JxQnfmMaBcHGZR5nBbPMgRdAJ6BZEFZDMJlAn2GqmFrOt/zNvp+
f0KfEv4PQFJC0Rlgm+9LPi5HIEWl3jq1hUysCa/2Ee/y9M6I/gp7r6UrW+xyML83t9jVYyMNhQNs
OCCOqWvkk4sN53bGY/vfazXfG5qPly9rUUXlSWeRbAG+Vv3J6/wQJ6kgXCWqFRPJ2kuSkboO52ed
/hq0NSWfedQuRnWuh0DKAk+tpZCPZdemkyHOPRXgz79P0db8Ved/M2lN/epyX4OlNJO/QL+elfQX
vcy7JG4kmtkn0UZvBfgxuOhosfLcuFyPaARUT2Ah8HpHBvr7UCqVNY52VdgnqM8nLoC96BNqzaAG
sWFl6V/tz5emFqvRLErbrCFEhfKxDWVVvS79ZJTMlatlrZXFIhwikfbVhA7ZtAgYE0RArvXno/Da
Avg6ZouJgb5vV/YRJqaAHa9Ul24BJAC3Hmwzhy5T+vhza9d21ZfWluXAWQ6oMimGTTHyLnA45V4k
2P3kRIesncTKerhSGMCCQM16Npr+LL19XxC66Nqk1xr7NE2lp0IfkbLu2DmKL6e2J/qdwzg0pNut
rnJX3mVTDn1YJVQq/uqk9KW+y3rrr5NRoolQU/D4QakwzpRzoZlkop4FyTOsAviLQSIHSsBZj5D0
7ucBu5yeeR3D4cdCYIEbcXGHiDbRpwloOmhYjgLYWdztqsdGT6fbUl/1UriS2rPh2oRtirLFLCW7
WNb6mNcwx8k0BN/PqbMBA72o7jsUJ+NWQd6TTy4d2Ycm3cSFSngh/WdBCLCK4VGCwwhvT8DUFt3t
pBlyLtXaqXdSzUONXCN6Kq9hw668bMC4gCjv7AiPeH/JDY0aSQJHLzFPjVaTsvN0ycebz3pSg659
GM5l3K68/i7XPepgs4I/VEw0HLOLk8mpwPiKaAuIVK/ISME0z3WBpJOc/ZKgHL0S9l6iRQHLx9Ni
9rHESwYF08Wy5xkEtRITmMNM9Ru4WWq5WoYAfuF966hvAE+mxEpsiCz1+RZW4qbHWBYaqIXRZKup
tQahlLzd6Uo/7abWePt5SV8BJIE1oAEkDu04zPMy+rK5AlIdja1TZCv7QTIPLaP3UFAgUF9X8Qwy
beGZHd/QLg8qTgr9YGi7TrF9pT+ra+jxpWY0mp+/ZiYKAwE/o4S+D9YgjYNDKWAm6tOIwMKGFMIv
x0V9C1RTg78lf5TBdW4svvl5FC42NqQTAcvCeON2hUTM4tzlZqZ20BJzTqIv/Sl+qQro2VQ3lngY
13Iql8v9e1vLU7cBjBPlGLSlQVzviX6057HyOi9Ww8YmaxSjeXF9iyjmxkDbQrkfyBOgPr6PJ0gU
elGmDI1ppt9V92yUiFRG0A8jUfWylkC/2FiL1hYbS1P6qMbp7ZxK84NNcN82ZCgi/BLIxf08Xxex
BRqCoTkovTOxHOv2e7eU1pyk3InpKTcn0uAaVuNXh6+poF3rzpz1QgsYOTTzvRVziFK4PiT0ZKle
5niA4hfxHu4vP/fl6oIAOhZx+6yPgazU92ZadA/eYGhGAG1wKzasJVHhpihp9bkb3f/c2rWRQ0YP
wCcgxIGqWKx0GAnoaS2lFM+SFvI6nlK+acXKmTJ/8GLR4RmC/gBjPVO6Fu9hFfwPU64j6WSYRecN
MJEg2qCuGeR+ahRcNDODQ1SIJQHHs5geluZ6xuNcOtHH9kZ50BUUvVz+V0RkmoKdeWf0PgjBYi13
eG2+gPBF1u8TzQyBke/zBXJUC/8LWTrJ7SFFhX8yDNJlr2bh9gyeihS+AgDgremfXx5ReEPaOKjx
wAaRwlwEA63TSIlRa9EZLHfSi3eHdaTnb5byYiT/ObcNJTFUp5GJRbAGjMHi1GjSPs2kUsTnofw7
JsqDzY8yzDmAxoOco+4N+srx+wn8/D6VaAvZMPw0gPBgAH4fUt7GXSsgmX/WcT4V3W/uZvK56WcS
FoRVxIEZfwaIUnJ+B7YUKWAPnEhsD62xMJnLRC+9drRqyJg72DAtqihrAj1XBh+wRyR45mgM793F
UhOTMKmTDMnZpnAkjZAgMwKp+1vTF4nnK+fBpcAaEMmzpiBW2CwHtKS/gcUxDLTWknPZ36flLzo8
iukwQTCamp0/KFjR741EErw/QEgv/5TtWYUcp/7c1xqkpoRMNAU6ejO/IlpDZF/ubESDWPezFC9u
DH2xMGQGxtVUaOlZSQCX7kpkzmE27qzEZ5+GQ4vlgCU+uwpCGxbktUXIJCaKRC9EUM4GvDOh1+Hl
cradX5E1xPki6YZVzZbXsmc907EiyKSoMRAowNkWEUp3+TP40K6E98UEB+A0YJ9g7hF6SoZXJGv7
cj4wl98KMB8uotmYTl1iCYHapFY8ydmZx25X3utVGzSIkwbzjavDhhYO0bY/H+FXFiPwt3juovCE
euyS2xCXqpILmO+eW2cXtw8Kv0miHesOAOWvXLOXLxDUfeY/AFa0Z/2fxW0BNfEGIs+0PMdVHwA2
TZJsIi16OqgGqaP2jCQCliH1sulJoeWxGfv/3FmMLcQPUIICahssksXJkGRWPdDGOEmS4yYTwBYd
5MxQ9VDz0F5BrFwOrIES91xDxB7Hu2CRQYvMKWtVO8G9VRosSGCDS6bRgP9opYDJpXf6WecQcP2v
szk3CtVNRABAUjjLtZ7HokjsTDoltaK5kx4Ptls6keKLHMh/eeo6l4HO9PRzq5dxIUBwyLUCWoHt
fLHDlMrslVodJWSA7Fa4ZZ0Ypovnu93ihK86SrqJOqieJnIn+8B7FepKt68sLVR3Znd71JeQhFqG
cMhPFboyCHwBjeDZM+ZQgAHwNz6UKA24PXymEf4UJTyObIeURQbdWLPdIJRVQ4NBDe3n8bgMi2BV
g3AS+cxZQn35SBvipCxhbpmfY3lU/FJSRxdtAhJQ87X44UpTSJqCHgvQAXLeS85XOSDD3cZOdu5G
TfOyGVs6tqC6NeO0JhB4qdWDPkHVCkBr+AEA8L24VysJINOEp8W5tpEMBqfMbjooyLZuvzcRq+Dc
UMdH7OMDDpF+8srW2rC8COsusIyKtO0YTEXz1oE1rK7stcuXHpJA4KDOqncIfS9GXIFDfRyzojjL
1PEH6BokSthPhUdr8GBelZa78M7RBAF5kln7vJD+24xb0KOaKxp4aUJKCUSDxZWOkyrXIsg9wFov
YDVpJuF1I1u5y5ex4kUriwlwRNXUpoRW9PS5tO6GENpQOnRZc+0VUqIOKEBQxVrZWotj7LPNOTEP
aioc6SF19/3IhMXi1KsR2rSyIHX+DGlosVMNU7riP7KH5paQAQK8DwE9UPnL6wEGW7pWd814QD26
BYWA5Ht6bnfOSrFrsWPmZnDT4RJCHQpZsCXflin25GRdJg51KmPM+Ll2DiJZ4yQsS6NoBqV1CBxA
ig1qiBfqTbxmbBxEKg5Wda7u2kONXhX1RuMkkaFJTKB4iXlbhfFeTheaRW1qZrsoJnT8vk+XNajC
QgFMHOyjRM7llgWyX/lQUieS/5cHWuxOB8VfKzUsLoB/Ovul1cW1YxaVGGoDrXa6geTKvkyJPqLW
/RClsI5bK74td/tFc4tAAvwYaI0zNCcysL2OOtTEh/ahH3b0LstDbkF4SfMlfdpMgIGX/cqDdK35
5QqKMlMaSgbnbfbHfoSzQVptJCvYMLcNowC8ZSCk1bVK9Mq8LpXaWCNimCKX4lAmNRzkXhrzeXpB
MtIdho+fL6/rLRkAYuOpBinWxVGmdzwfhJCwTPh9Kj3K9DVuPzT6d1Vz7Po4gkgwC5lgsS7Tc7bT
86SeYnFIueU1sMeaZSWU6SCNB6XrEfi6Nc29XjpMinRbv/aISn/u6jJd+c9Cwq9YLrN8uLPoq4Dw
fT2xXBzibeWz2KviTa2A3kLv4ztnR917fl/exn+z55/bndfnlyj/f5t15ooZZKtA3fm+SdVCZnCK
wfoFM900URCEYlig64SxHCTFnXr3c3NX7o0Z5vNve4tDQS04K1obZ9EkHyVx3/2G+yO8ID0zsaE/
th2BiVxpce7BRQ8xoMgTzl59S+BEDfW9yqorceiDPjD9Y3sG22b+c6sTSt5TVybRyu149Qz60uTi
ULC5NnZQOhIH2VX2umftINALPO3PHVvmFv6Zun9bWeZbWyuCgJxAK9wvz6r7IAA4F5vz3VtPfkWe
4pYhMuxh5SWe5r7/3PbKmC4fFNYk5yyTcQQw0biJDlS7aImqneNp5ZW0ZPZddFJdrE/HZIpRoSVd
DnU18qDU5xkigCpFlb+U9AG+aH7bh6ocgYmibCGC6k7dlvGVg3aRH7j4DO37Z8C6ye5GB4vIob8S
5y0bV/bF1ZPuy1zO7X8pz9tCSxm8Rea5LOo7mz7lGpIfXqbH4c8zt4ycP3syA4jwNxghoLl/bwkc
bRQ84PZ5GIPY1Z/EBuykDQMi3ArOgGbtFBcHQVDuAMLunldbn8dpuRm/tr4YxyHiXS+laN3cGYEJ
WkThxkFybDeWn7h4mhDNpW7r6cf0KG31vYpds1a2unbiAbYyx5GA+UMs//sAFCVVqqjDULOg86Xz
GNh+FBhe59dbdSKKZw4us0jnwGIlAHWycqn/8xQsCQD/TMGs5AJ4EyLZpSxuZmhTB50fcaieGBKC
d+1DeaP+tnoPAl7P6p65mtv7JSn3w5mtnIafLqgXE/Cl7cVCs4zcLnWZwyvJb8gUqmG7bW/GLf3o
D92tIjzdgwZQGLm/f9Xuk0Esj7vvE0n9x/D0+Aj0nuu4dzn5Hbm/woeObBPwWSTSuf7vQ+SO/uEE
pntggINz/zjszbu1mPLauaN9+fo5oP6yTbjI8YiHjOIBguwHti8OuU5WJmde/xcDNOeEEJujNrJM
0dUddC7yDqlZOcqPRhUXLtMgqynJcu7DbUc6FgNHAajsercy4VRjIWVXtBzixiNUVX7+mGunzqzo
L0MqbIZ4zcPxpbtMBru6SVRYkTZ/rPhc5iun6+Wpg04ClgM2qoOHwTLmgEGwQvXYsA9Md2+yAz+U
u1UlmCttIAMBCQosdySflgFGonY6CNApPdiPzZPsx0Hl4pUYjK4cqNvJM4kfk9wfnn8euSvHHGpO
AI19amBAtHjxVjRiuS87taWHoAav7hlg8m3/pj8gpMo7N6zJtNWfJ0ZgJoYqtXQzrrzsrlzOaH+W
k8UGn3UHF1MnFZE28ILRwx6pe3OnPkmn7LV8Bx1t67w6R+hSPzQ3LEw33QaU+Bv5tMb8u4xBZsk8
0GNtVH4x7Itjzo4VSmvVpIeoyGBviTzAjSHdpEBsZmRY09D9JEZ+3zXfW1u8uhRWK0AfWPQwuBWR
zmAKkDFwzmo4+EaQ3HUkD7LQ9EZQ3xLycGd6Ebk5PZvk+QQ335thO/qypwZ9KJOUQA4P587P6+Fy
JyFfBMFTZPmRmnGWqWUnFplVARtxgFAc0Rncvlcu8CuByvcWFgsukeucogjtHPRQCoyXLqwea797
7J+dx/ZU3ZehcoNc/s+9uhJNf290Psy+HBC0KCBpNKJb3R3bC/AGhV+COVi6a7XcK7t4lvG0oDKF
4whZt+8N2UMdF6ON988sGs+bU+Fr2a2uZDjpf+7StY2LfDtq4PD8A6H08530tUsA0TErVqRDMRF6
jG/6rbbP76sjlFn1rbylm/g0HYxHfR+d6Uk6NCvhwbKjyNtBZwy0fAiBAzpvLaZRKcx+bGoNkiMQ
VI6S9xJ0rbxCbQD58apZ6ey1xhAEIEuHvkLGd9EYlSfVrEQaHVm3LW9wu2yKCJodJVRQxYoQwPI4
mPv1tanFSmFT26p1noFETek2GW1OpEYK4C0HLxrUllJkCeRo7YmyDLWWjS6ivXGK6rYs0L/24WyD
8XI0txlOWyzRt59Xzae4zdfz55+WoKkNwgG0b8zFcYtUpFbWsYT1kJP+oLp1kHswitqHuKERtJhk
9KFRFxRn52bNquJiEy7bnmf5y4oFhkhPOUfbjoZaXPRginCAnd0x2Y71RyTmYsP7z929Oq4I32eT
bezKZVJ/qlRqdRLGVWGhangNEEXySwq0iEXvpq2VrOyJ66OLQxNWKjhDca1872EFrnUuMiwekeT3
OVA9TV8SBbARQ9tqj3FxryaPEYUcwr6pzml+m1u12/VhX8YEAuN9/VcFAuTnIViiz+YEO0p3//dN
SyxGrozAlzgYAycmSDCe6Y4fs8dpwCmRHapDespPfFsfE5msCd9exO9z00AeAaKIAGnOqX4fDuih
lTxGtfxoEKU9pn/qZ/qrPvMQ7u2HcSe0oAOk+qA9ToG0XQOML4von/3+2vjyph0aPtk1Gm98vBX9
cc/OxW/TrdzsmBxgm4DgfNr3vnx/km56iOGslU7nnbTYabM8E0BscB6Y8+TfO1/pOB75oEeQrQ4L
fu7i25HeqFBU/3l+15pZbGitBOC/4Wim++h3wl05DZfhAGYQok9QDgGWZ7Z+WRxMsA5JSgRIOHjt
/hdN2m3Es5WE3hIVPE8UahTQyUIJAZihJdohBoEC7+w+PqZbOwRvfSe8Ytcdjc1R8s337ggJlnzn
eOJY36aEnimyNBtAo9oAqICj4zkrsf61DfPtexY3AFSXGm4qPD527VNvv0ITi1TcY9OfFlImjzAj
xeJpB19q37tDxqHZTZLi0UBu5+eJvXIRffuMxdDbDnQ1EhXDklNKHCqIo93qkpfxnZaF6RquYylX
P8+CgQILILHwSIFyy2IdtQU8m6NqTI4oxQ5u5irPKA9O0P+PSaITcKMZqX39PPpIOHxMe5iuNgR6
yZ27+bnbF0WYfz4E6V0gdJF++Yx7vtwSg5VPWmwOydEZ74ExKLXTELWuBRpLvMnOSH4ejbUnwLWD
ChgDmNFBjB0x1VK7URlhsTY6U3IsuoMVNICUWEFr7VI9SG7HcqM5gd54Jn3Ik/cogLmtfcB7qFor
QV8k1+euf/2MeTd+6bqUF9kQmSI5atHvQencmsP8vDsXN7R4GcY9rx8ALAO1wdS5KxnPPw/8lbvS
RF4fKkiAfqHGtjgvUZGOcFRb6TEzn22QXqnhGgolGWxoITOg0NkI0fu5yc8L4NsZCU4ZjpaZjK7M
eYTFBQFmW1NneTMeC8hpdEiPmG5HTFf1+xvTFS/4z69vN78mL8OCFOQZbsgeqtjIn0AxkQhEK39n
KaFn6LO6PiUbThxvwMPI9WQE9/vIq5EoS5EaW3tPLOuRyDLYeKqj7onElAkNse8TJWon49zpxmNf
PyQSvNlaF6qePw/OxdE7t4EIfwZJqCrQ8d/bQG28j2jVj0cOtemhK0mWrmWJIHiH32Q5AcjtQYUc
ClTox6IRziS4xcTxdJzc1+O+9zbuS+uJP9yPNsh6qu7bSJ4T8goTKvKi+1A8Kb3Q3Bpkcs8PUHFR
CNm+Pmz/9CT2nnvS+ve3txrxdofe/fVRkN0Q6MQkN0gN4QGbuxvfHchJCfGvrffRu78/uJ8Rg+Tu
4H6YZx26GWBOk/c+MPCzbhvcw1kewi+AfpETkmzGGSn68KCFz4P3qySPh5z4fCXxd7ENMOxfR2QR
wtmtrPbDFGFEQtE9GJIn/xlLLE2Z5NbWKVdSnJ/m8T9MwLIuKUHgjOuQOz7uj69H2fUy8lSR7fH9
dRveHb3jedv6+Ovg73a/w8PfNnzZrOxBfZ7in75g8bYqkjGFISu+wHxlXnsw3e3rOfgbBDe+5+PM
J/c+xLpMEhJ/458O7tPm4BNyQ3Yk/O3Z7tqSnHfOT1+zuHzNSdcjS+BrMtL4L5a7pnt+GaJ/n98l
16SPzQTW9miAtVs4rOa45D74X+mPyf0KkpZY9Fvhd3v9nCe3Uk1kr3yBdO/PW/syxFh8xLwtvxz0
HWTKlaLBR1T1jZyHeWARNYPWO0GMbk4P8btE95WBnLEEU3i4z740WUl4vRbcrQ32IkQte0qjUsdn
BE8lNvXx5Qw7L3efkaODHf5AsPlcrIGXILhjuP8PoX+zCw/3z5rr7h9vsQPf16b/8iYG/wOI108k
JTg6S8YR7XsHYlV9fixU4GO2XffYVaXXvCblMzCtVZd6hXyIEq+cjrA5lTuvQZIZQOi886AwvzJP
2hxjLVbjTH9CVR3CgAB4LvaGJVnpYEgiP75IpPc8to32wKOd8vPolfCa36S4mRoP/qcbe4sBYqEd
EYrD0gNI1WuCj/TIHqGstbJ6LncsZHhAkUGmG7Rz/TOl+mX1IB9RdkoZd8ekrEo/rproiMsoA3CK
yqGjUuarRtSEyjQyn7WC/YFIibMtnQrWdFaee/lUxkFpQ3O9dKYiHLoKXryWGfkikeXNzx97eVPi
W/WZBo1/zCyj7yt9VHVhVWraHevqF6CTXl/cp+MagvLqgOiYKeDGkSL6nMYvA9JYDiScHTRizlnb
B2cmZrqok5vVymEJ7se1DqEyDzUUAHARByzuh7FSq0ZrJUijWlask7zVDdCDaaLe6jxSfkd6n/4R
8ZjLLpT7+iOVJPZ3mkDfhFiITqEWNRXloR0AgfeStlBe27JRwIeUko8qz0xgaqvBwdNYG3mQ1wjH
oUZFzwKpvqe2HOqIZIORqUSf8voxByy239E8qcJBUqMxVLgoH2KupYabmvEI/DcFc4yAQcjDCRYP
qOOPlaRsc6PPn5t+gBR7rrVjTNJBZ+/NmNpPbdXE2rYuJY27CusTIKutXDzJTQdBQ9eCgORUH4y6
m9UjgdCU049Ys2gEwr5NHasn0MkYRFDpRlltE+4UU5DAH0qFlTXn6dvEIVvgZprWMi81IMBCpmSC
n5QZMTG1ZMq0pEUaJNMh/mZCpNUDUTk1TnoFGvG2c0pDI0qd1BmhGueDZxq5oC4EakZIuPSdJvs9
9JBlV2syuwhVYfJkg08B+kaKKvbOIiweoMd1+LihuKsceS4DEQcKZGmQPjXZc2VTWDZkBkvMvT5I
4lgWnRJvY6Uc75o8a2EbWBn1Ic5N1nt9DWvusZCjZ5EW7K3VC1V2q6E1jiqIZAwgJmHfN7AGa8JU
lkGByScdxGdl6g2YpGZ95kZ1l3bhWNtZ5KZ8aP+OQMQrnmFVbe6Buwgb91yb0jSYEi0DxJrLxrZm
hfq3MRwqhaVeSig/l1LmJ5U9iqC05ukeNQ6KhJ0XDHh0LrEotByjeKAw1qxdzgwGlbIMAgFW2SqO
NxlFJ0iHEgwg65mVlkGjRcox7xycZUOb1eeyjPN7/BToF5GeaElQtDVkE+B2295WNFHSvYjhfOEp
dQwVT/hWKW4lyeq0sRqH7YdRnhR3hHHq38yEpfhWq2iBzGrL1C6oBMPSmCCK+55WrVURBpKH46uS
Bp3zdpS121YbaAojVoOOG0jBWJy0TScrnqNn8R9wy/kfR+sHiaRSxxrCjTGqCFzp2ZPUKX1KRlNg
0qKIcdmNTLWFeZYt+sLP65iD1aj3DrLVetY+ZhnokaRB+W/ypKJLNK+FXERPeJ/QkowDb26HUVNf
jK7RwzSW4w+jLGByL7eTEdZprCiuUXXlszG1HTYD5KjKoNZZFXvw8JRUUJZhALcbkpZLR6vFS/TY
SQbnvlIm4AuAtKGrLioy/e9xaJ2HEZ5ntwOG8pbLzAlzzNTklmk/vvfR1MGwOkGq3FVkgZpcUjHt
SehJ+gi4OtKLkIGgRB0d5LR4H2EMKoq1RqyRm6BFDBZmVbGav9oUl3grtZrYRWmCM4DhFsyIxqDa
TtqMdbkraFUxgjSWkxOry6sOv+2QPSk8Y5mLnHX7NpbjuFWkYkpAWDPifWnFTuPXdh85LkSezM2Q
wiGcDAOLI9dJqAwOe4zji9u19WLUDrU2KhvqnBRlaUu+gP2tLzftfNNXhnScUgVJiCwrmse6Ngp+
6G01x2hliYSzzVGL95zBy93lnONDE2HmULU0CiVxpTpRI4iTyw6sCeBp+ACER4PCCIX7DEhEBt5s
ll4Y70ZLh84rh9hBp02zACiRtsqjpSXV5CEVYb7BmQ/xn+hg2efGEOF6KJNi/F0PTRa7djJpxkaf
Urs55k6C2qSV1h2sbdtYmxcaTgZHZe0Ovt0CrpOliZOLqblR+sISsrZJ5TZ742PtWAQ2B7Lha0oT
QXnH1Lsd9HMpajh4Fw5kgHCO4ur6hInoB2cwfUVJJ8MDpHTAe1kXrHZlWmgvpsIgc9NqvAIFqp1k
xy/HSJ2ddjr7lqclYs00i/i2NOP0KS4aSwotXhbPTqlJ7dZ2uioU8sihIGk0FcyHqJCyIIdyin2M
YydJb0ESj1QPTsWAq6MgM+xHHqVznkgFDavNzfzYiaYyQzFK7N6pQWpAajjL7wdV6tKDJPNKAWJQ
10JYS0QtTsRkegEPaJhAWRLsreOWw3ykCpLfI+Cp91OVdhpRe9u45dxijWuXVvsgWI7qiFaPENd0
al0rPGYVch/aCB6FnzscmeUkGnmx1XXawdbGjuoylJLc7EkaNdVDm6EAv1FMLplhZ0z0PCq4clwz
69FpSS+stxGI9+wsjKaHRHpua9q9bLSoWugaberj2NX2sTbrFPYljTXv8SpXM3ewG8Y9FZLO015i
Qxx7MfgMJpgUGjyWyog5KKpTfD0EpnGLuSaQTBhGKGjSGz5S6wERx6CQPLENsS/iZkJ7rQ4PyBwG
7bWrqMgmu7HWdr8AiLbuqmSIf+HtNqS4qRUtIYYDXsGhQ1TANxnEAOCbypM0aBIZsVBuOHCGG8Uk
+bLMWRbUc2NeG9sq9nhmG1toFtWDq6mp7DyJSBMSsSO1jzyjbDmctSQmXiMI3YyEYqAhiiYN+m+t
ryGXVoKsdIz7ulCDuEQ+l1BFpuPWaFqnd1EmTBJE6nyK7pGOdzKv4F0MgkesycDNwEMk30VTFlm3
feJgFdWFbDG3r+W+I9GM0vZwphsAO8lWDO/HEovbpU5XP9mRKUP+tRslQKXziKWhzmq99OWojT5G
Ixtrv0gN6wxg0ZxB0awh8/JByhnpzKHBBk2AGvMokqKtJw2VOls+WpLM3EhDKyGHRD2DBDxiGzh+
x2yHuZDPkplOdN/BLyneGBz/NwT7rTfDXqnYA0j8JTy7ad3JQWMWWbOP4F+7l2hUv5epkd+BwzeN
HotzwAvMqOaJ70RssJFdrPRu6whdLw6gbNh5oEel5WBFjkiBVpraK0E0Kv1trrM+uq+0rGnPdt3F
0YPBmPpYsAocmQ41tA60DnXqBWknxdJcETVy8lSyEWaHg05RbkIIguOGjdDfh84ColV3YoIB4MFq
/lwNivwhejh1wZFEB3sNaNgkIgjgHSWgrMkR9CEWBaKn0PoYr2WwiAKeKcmOGXLp+BUsS2vCSjYY
m0hVm+hOlI4ae3bdlHizZVzJobBGlciTJ5o+MtmqBi+SQfU7WD1kEDzR8ToKRdxWQILq+C23eNjg
MayMWV/+liLHiu5hmIB0tATBds0buD1A2LHMEEghYrCtYbqvsgpydSW+qvJ6a9SeGVbHq0pNpQ6o
wC9DDDP52yrBUxNym0x+0RRpjF2Nq9VdJ0Xij8FkO/YVahe3BSqIu6q38Wbpkzy7j6iRNtuWF/Kd
NtooBs+XLuLLXLXfkViIX1Hwmqa7ArQ4GCoVUdOTgbdGHMhxKWo35kqcuEZdRamblH0Tk0rq5KMT
yeMfPe9tmwxJ1zhexhIK0J3ZYg5bXGIaGSQcBQCkRMV7TJW+CYqKtx9FXtHHxuqVDsIS1kxzTAwI
SWg2tGJRdWrhpUILCy7BvShQ7p3KvghwkMGQL0mt6JQCdQTJSrlRb3CHmDnJ7Kn8VU3T1APY1/fR
ZkoG7KMxE2IiBXxiOmIPCWTHIZnYT38VZqW3SkbFthes+OPgVKN+0/U4GBNYW3VzqOE8q6VhIgiA
nB4HxUCbjk7SxSrpZU0UvpriNoDOpHPLR6t4qkeFhlmporIjOUaYCdl+jqSsgJJ52d/KrUypm+tU
0X2tb5XX/6HozLrrxIEg/Is4h315hbt5ix07cZYXTrZBLEIgQEj8+vn8NA+ZONcX0equqq4qhA+C
I7a543GseXzyuyTub3kkMh6o2lJxzRp/Xs9i3ux4T2D2ZM5tsuM4b/1jo+txOo5PWD7pnXR4QyPe
5hp4fcBKC9aJQOj7JmFAPie2n9/rcAMMFzn9PkuPWLZgC2l3Wy5rmNvzavsiO/daCca8mZBHmpE6
bk/Jpnx1Yqo5Rnr4A8IIYN2TAIpiEpXXZcX8z+0Z33m0NGKjR2pldzVdsayULa6fJ+Ywpa+6S+Rd
0ui2v0WeicNT6Otp+Zyh0ZS8mNxZwzVuPNOdYmfNZckG/KlGf+uelYmBVHxySACaooEezbfsp1WZ
ZqAmiTi3ZEMWR/p9G8fkW7R2TB5TvLNV7OUdQRXjavZP3qYL/C7Tvk/gApDcofs3VldONflQqmY6
zgmVGgddDfFepiIZgeHxx2zKNIw2YrYz7E0YN4C54l09hlvLbuyBk8j93G4WxWSK4LY8cm/CWscv
LKRjm31vwpZ0iWV0GwJc6ySNdjwWz5bcuqkc5iaFoNqSPi3jRZIPkQ8tnpQwJO5P3WQDu9CmGFje
XFOj2PqYxs+q772/PrFnYG2FkY4ocT0QOJDmI2H0nCfymNtWvNlEx5+XYV/zc7zobCHwtMGZTssw
e8INNGnZ1YQwKY3w4EnmtaUTJUZt/09D4Ux8fyZ+mPmzo/JNMjyza8b4Tpiv/GfCvf8U9KIZz/mk
eSW7dMzxtaZraqqh7aPs1LAgzi5FN/KZkti4F98Xnb74IYWGijJnXzh54s3sIgez80XjnYJiUEgE
xxA/EasafR4OMVsM3vkC+Blqf5FN7HeEK/UtY5TJu/voCPuh8gnG3qt030gaTyEZmqDDr4PG7WiY
Z61JSmF2X5R04Ou3NSI0l13DFLyppR32Ve+rq4RUDEsx+TMmcLwNOPDGAV+WDKf+Xyd14F/ipKEM
CpMX7lykh/jjNnzJCckmfjCqgTr4K133wDerG7rBVOF0y/TKt555by4c4l+BihS7qLpj33sJ+ig9
hWgP2AQ2zcHycW7lqW86Ytg/9rHTU8509yMf6tg/710qn2V72PRceIP44ZhYgYe2ZE3KeaIdKgcx
5M+Hw3zr4g2Oqhtqorpf92SL1DVuezGcWInxt/O+Je05DinBNwmjisJeqyEoMTVofpAxZsZ7hgl8
9Sk+4Jdt7jGyIrA8QuawYVbnzAWs9jZR2t8m4igyNh8H8WcejHxR4NLiFs59NN9muczT21Q0A5c1
+R2q2s2ImGSYSfr+ooJRt5dcHGt8wr9Wmrs1kPq77VXOzbgkxXsj5USoMVdoVsaHPzEK+xMjSyPj
KbgdgyXyXtXJGl0CQb/LRmqAl0BjtoPLAx+ZCu+n4DltOiq3Hf3lWYeBornuvZD3XnLHlrXyQvGo
NJuaD4neGBhZFYQnQShb0OsD5N/Sfa1dteNQ/1EpQ7OdJhGPNLGrjCbsjiik1K2u5usK4wkHJmHj
vNItc8AJjPidH2dJPjyAnkSTbN+OXClbrbMmsFl4UJbP0vMXoJgVXKokeOSY7qMksC0d1arz00cq
M7tdnISwCnTcYNPbs59QZlm3KGKLj44geGKI8Pruwto/KR+3iaiQxVQyHFHtDn+Mo2qPyF6roqxB
994vDcGXtcK/p1zlOKPTrN1GxF7TRngzdP3xNu6KXnL8WG4pXVR7c7UMKVwCSDsEfs548s8/lPfj
mJM1uKR01yuXZh9HJeFMHjbE6bYWz5Mg1RnQv8+eJ93sBXChDUa6y55fQ0WiLUqlmzC/DVEifxbB
fLyHXujY/DCe/S+Uh2WWibagP8WxzXEGdvUrFiKceAIhuP+yqOEa31AWfPO63DBfJD04WAF2RSLD
RNb6lFOiyyLdPqrewb7lhXl6QiQ2xEv6tAU4tl83N2RD6RE51p22nid6Hjqvg6t32bbgaWv9vOrq
1LeVsOlKrMZo1Vl0jY5LxmsQH7Fvx69836K/o4swnSL5KnwzM4GcpVjojapsjHmZVSZUVLpU9dyh
RST/mD4txir96PBBCbWkgC9N9CHLUBu5eWvAVsBQDNSxvWV4qqXzPOYuk7HpE/bqud5dfpxz307N
aehkFD0HFjO1iuSa7d8wERFXmthXT0qPERhhq5ZvIS550XX0j/Upz2fVnpwCpyErdPHHp6LvU3FL
M7MEl5Cl6/DSeQZeWBCZzUsW1JG5wPnsqmLPYbWPfaj95uSZIOpuhtr+UiTd4J3CNsXMJfKyrK3m
I1Htc+K8rn3Yow7TpgWzCe+sdzWFZe/yNq7cvK1/IrHifZdMvszPRYgwFJsMLAXOZo7D36yHZzyb
o58N9gk6Ds8HJowsgOtw/5abzHySTuEz5IeT2qqwmfVPb/MKutdlS7aTGYeEBkB0A7dbMKXf9+QD
i7QoIu9U4an9blK+mKvJBZE6e+OW3Aoy+9xJsh4QlGMjg1u2MYCciw8bSHKapcxLKKCCWtp4+ad5
9Qp23wVdlSqNpTScsiyI2BN1XNjsry+nrdHD6yz7AeyYfPPs2q2RKKqOxopUEJdbDeyvInbVfb9V
pTt4JapANj4os4RhvRSzBiKemcsIWWoKNtvmxOtPiDqlq5wW8cMSz5m+Nc3HaDH3lleMgN4c0Tug
Jrq5TOq1Cmab4dg1hvZnxylTlRmGnqZ3ylvAz0JMp92E3b23peyqt7EXAcLwJfb3S88NSJsVTw/K
4AhbWQDTT0TE7LoqmNpuGsOf5dQr6xNF20v1uIrN5yMkG8IC8tGj8jhU+ycXOTWwcf47oE5Paq9y
EQ3TyPInrcysurJg7XKtwpquDaRozf8L2iLVGMCaxb+GU8bV2jkk/6fj2PzxRiMiibvijP4xPC66
Auwnsmvmok583yJd/6Ijc6ISnW2FLKd5CpebskHbAu760rvvgnHeL4fhPyWMElxcHm1zeDm4Jorz
Wi94Imq3ueyEyj/Xl2Rc0rd+Dvr7vRlS1o2neE4GUGmqV2NsP332BtMEfrkffhuWefdh92h7hNSz
tc5BXW31Q3eAqlTgK1FS+oMyx0n3tZ1OGTDxd9daOiSluv21SWX9PRFH8meuu2P83o+0mS8LV0jy
JeTSdndH3QfihU9pxYkowISrrS6m8MFP6rD+uSt98MDGeXoMpl0SQlEMjap4v4zCAj0jzqAhPPOH
ZoGKwxCP+Zd5z1kbqH0jaU58W49vbup3ypqUCxhruLgm36thVbK/TvmSgsXXuDyr5z22i7prwlUR
IsJYPY9vg/MCnsVk0va57wgFPyW0uTxprdrXYVAtaiymJfN3wN8tBySHNWDMR+wh8fCLSGdk0frw
5aWuBdYp3Hv7rMCEk2a7XzsPS7OtH4V38uhW93sSCIOvIOTr05wxwF17ughxxkupS57csevfzZBr
x2L4GK+fosHHLSESToJgMy0yehcqh63nJ8k72Rsz39bU2uG0LZk19wbWijLtBUNL5xZsT3LRbnpf
XDq0IA8qZY0XFJ4N0GWKb4PdfHlbjUKnXHrbKMITtQowXkaex/85bTmDJNYJ4n7qDx7aZjz/Bx1v
2pVd3vu6inOZQA8F0fHxyWIeWtMLhiFojjR7ALFblnO9dYc7YbXqsZUJqLrcivwYg6pfTTq9aoak
4dzmFNJT1PT1fEm6oKmvLIpEX+OMNoXvDaeYU7sO7qcgeY0mcpvq2pwPxGTrNdjN0N2txRKPD5aQ
5ZQk8KzrTmm/yvbbflAT77qa/qYG5HOBCMDAozX5F+EujrzuCNK7tYnJvC1UlP9g3Tf4Lr1lcn/b
tcnqP0B1NvvM/frhGOPGD4milnRJIpjvj1gpUk2TdqCNHT+cDNNdeLclxpro5GmhHgO80Vcosx7V
orOgYzoujhulSvtEXY/K/aeNOuSDlwi5X8SUjc9LG8ztU5263aeF6aFt4obYRraGdDhU7TyNx2tP
O/LudfR5lUvT4QucOqxO1XvKefdFW5j82zSEx3WYD1qKIzyC4c4dPJ9qyn05nZrFV9k1lbtKnos9
aDMo7X75HbRRikDX7UNfTmS/p7d8G9bnbF86jF+XNTinXXw81WE7hueppvM7R0oeD1b5Oi2buuiS
Mh519xeTKD97Mmre+B0m8DB61dSmFXVnEfdRZLR+TVRooTuU9Nm37Hp63qaXMci0zSVA55oLJpKQ
JQszyuMunPPui2g5tufBS1GDbmZYX+dNuVdDk93eoXAAZRi5ItNymhSDkajJ9+UrzV8YNOxTv+7p
T1PwyEoVC3PN2qPOyyyVC66JxRqVMhnovMScRg1nIZvR7E8tdt7TrtPPAXCmBDZIySyv5zm3JViA
U2Wwp96XHuTdw+XR1lT9seZK2AH/CWyYXCbBpttY82kUyykZVzWv0Ry6c0bR/rK7afylQfFeOrPS
jnm+VlV8HMldOwBBnSdMkIMq6Fc+UxsPej7J2Pj/jTKICDOb5uD7IDz1qwl7UiImY+VrTJ8VnzZm
b3teQq0/75iR4OSbmuPbNhDDh6PPmJwP4WZbqY8+Exoj7d9FejCby1TA+KShqN/7YUkQPnzg9Svz
99migWhpaeduPwlr2v1k+iEteCti/VbASQNVra1DWAieMlaLmIrvTiC0vBuYAT4d7BS+Na2ByquD
2dNlvRv3PHgYFQNvCPOrqTO6ftESGILllBvvl7Hr08sejN1dvewOZg1qCMsKEE2eI/M8Z9SLMeud
loS+ppPpiwMKeOeOiP4g+4EgymHHodpq4sAxYkw2Bqdteo/4IocSoyVNlJmWxDIkYxv+SjeChJdh
niAygnnuKy9fDaU2CvX7Wvj15yDGjiFfj+KLy+veh+ExhLsGrQbvH7YB4A4HP/2ZLbekO1MeaU5k
0yTfcCcT7XXOrLiKOPHbUkNHPdp9JK3A6117H9lihaRRcWd0ldII3tkilqo8IGn+NuSzziUYqPya
NsEIHgZ2+IozxLif2QQgOYUMcnJCRCCWCMd2emlGCVPzpIWL7rNBNl0529b8Ef7IWiV3M3htkOwz
IbBBZGKweqjtiuV5CXc2xba7TEvtv8z17GflboG7SIqxPN8t9vf1qicFUrG2rAhZvCahlbH5/9qb
mjynqZjHqhnXDDKpW9Mvozeq6HGRkXqH/SefsdgZhatxGXJ15bcOPzUixl9v2dvi2kU0DlARNXvQ
sm1fyQsJSavtVw5V3DomYTm3w8dL7tRtmrsBhsPV/ZuYl0OeAlHY8ZxsIwbefuTyP0cXsYe2yXp/
RTDQv0g+5vPWJDsnYvkgN5iN1+/KW9Uj+EDz1xmxMEHSvP1a5+h4kn0IkpO79F4GH6ssZi2St0iI
hAWOcUj/G+0RFmfTben4ZiMYN86gm+62lWOlUft/Y8T4QM5NhuTMNKN6mPHQXMDdwoW2yA/vxODq
7LxEiUOYlvbiVzHY9XM/AS+Q8w4SfAGmtHVl98j+8uJxHC9u09N3VBM0P3mTtOmJ7tJLUApsy/0e
umCEA27MDBrZzvNdL90+XTo637dMRMf8AwXq5rE7BoUur5GHpLaSmTdfPNvo+WFbCgjnNHIfp4xM
2ANcIRTxDdoiFLDmmP1hBmjceLEpjlpXsXpHeOuGQn4jN2aMAWx1Ev0Gkl2Dr+zYRvoHLWaD2mLH
1AeImb95dH1nKwp38AMcfkyvq11a/zyofeUL1Db1mKb4p8H0M7Rm2xZg5IAiek1eiJ9q6Qrbeprv
k4OG9hRuU/cjHWHIcSCMJ59Qxz5GPQHLj7KcIaS9MZ7VO574e11cjmPFqCnuQamuRRcMM+tmhOuV
S7arf3kBDwUA163vGbNZzmlP+SINOsa+4oVY/wx5jtvhtB1sNxXb7gX3My2+vkRyAwsvZTePX8cG
ruZPzh9nD1i6eW2lJ3KZzylCgg1WopHRCQfuyWtLBwOSnfTBD3ykpsXFw1Qv3ddhA0anntTZS+LS
+L9tdn59XvNgCsrGtdnPfAzwAlD+5kMKQ8hf0qTz9lsnWBtBHc1cirbJ77s7t8QGYzW9KpCDXPTe
ck52S5G1HijlhW1lXC45doADUNYxsrrDjezXG48XdXSefIlU37bPS6KASFNAFAQRMWqbe9rXeIM/
VbUtDU7tVHOuXFkNSdyOVaRDRwM758mbHxSHgTt2TJQoOnrvaZDZvDPzFQJELfL74RL1O0vzLkaC
BPmZfSScEp32tQ+DD7pjwHLnzrq9zkqVmzSgbhfJWg2iYAbaaOxzwiJASnfs09sKVD7/zXts1w8/
uRVi0q5Lc8IgLXdfw15z4+dyX70zUqqpu9cthvilOATsmEFNkZ5NyvBaUVCzjaWpxkWneBOMupvr
pCLAPozsc7MvAUSvhqY7zl64dMd5m6QTL1Y3KSZHC0TUSxKhAxTUU5NtLzug2n4aE3WIezUZiaFk
6gv/auIh3O8KvYPay6XzvRckVlbc2nQoMqZOOz7li2rWoIy9wnRfwfF6w7wzafUaadf6DuInntov
QZ30xV1OEMR4vw0eNrm1AG3+1ogpmK9jID/iow5//xIxpaWlCLRDbDOIZThZV+zuWtQqA8brPJbR
lTfZv2jHQMX8qMuwoxRz610BLSN16fsjXy61g3NVsdt/m8jbtkvg1aM6jSp3hDkfusa2Mlbo9Ryf
C56FIe9FCrM1N0NEBvfTSPr6Azq8VVZI9oCNRGJAJXyQKABMuY9FtZG9gj9jH2NYN8iQtTm54hle
5queptdGCgB7Ltr9OAd9whrF3BYfGiN/T921n/P1B8NO8zmzDbRImLXEzC7IGWYAENy4zms/micN
3X9cpDc3DZ4KNBbfOxLuWNhrp7y+8JARxo0DJHAp2dhYT9M+qQJxRXgQQheM9fxYdKLtS0zp944c
DMVhkmtkEZnpWdnvA8rFucx0uJj3g99SfV5qlHrnLZGReDUbJPr3Jvf6GFFa3apzEqiBntsO0jxr
tgieZk+267cgPMyE/VI687YZLt+qnluyq5pgIVh+auaWrwIH1q59kxKipqpjtg2qRcPxgm2Jo35y
o4phjbKsZwHSinS8Qzpp4/txQXV7Brdu7WXaClZDzVTY4EKHmqdnsJyRjQMeeX3nWjxIPbgsdXNs
t3RvWwGm9e7nkwjvR64e8XfD13F9CBxbzGWX+Ym9ub1PH4knWcW1qa3E/ZKYM/+6pOhRnmo7sLKN
yBLrqu04AOmElx+M3XAL7VfPz6LlMUSrVnxaCy/ffsRTxM3hxc0e3h/0OekJ0k/riiieQZ6Ode9g
JdGNbNhEDQG3Vl9n+SNmS1lx3Sw0420Y1qIHMiWbuK5WgjxR8TYIJspIklR6IZutc+c5SuqCU7Zm
6DKSJRb3Y75zKgkhLOx1Vn46/gtm/2iRbUVo3tapKCTU2KKs9zWPe5mcu82ruytiDdufvMQE0zNV
eXiZZMA1qAJsVl8Gfr3iNmo71O/j5lnz6gcs7VYz11X91ONKrEsrTfMn8FjTfgz6jMqcAlV7D5CI
G4QcsC+eDZMIur+7TcP5gU8Q6XNjFakOGPDZ+q5rwQcQbhwWYorCbYfzYfchuPjU5vWLB7OzfrA3
0H70mznyRLDqWtxtTdj8AZDYR69EexN92FW6Gi9sqLzhboMQgFQupA4v3lh4+yXxk4FBIOzy5j71
FF7RyREcX7Kxbo+b57pQXI2BBi8XHdd/+pQ08PPGEvoAWcK1jSXpwtf6oXxh2GBK3ti6yrxpO0GQ
I84n5zvl+ii4rNGo6fBDUbJk681Tm6cfeM3RM+SHjPvf48A8VrpwDpLzXpgwPcVmS0CLgnBKcVGz
Y/eQqsw8FHPHCOhWD5emNT5ie2dsF4Bhy9hrL57r0Y1EiYrjKiSBcORMCq5Vf3KMBbqml557yNir
QopsS0nTo0vf5Kt3Ql8X4Z5dh+jwWrAf2Ax0WizcFDCg526c0+4HsTz+zzGezQzyoOvjhPyi0KXe
s+wHRHGcXZNcBW/MR1geubmLKX3dMref4E7kfrUjjM9dN0Yf7/LqW979TtoU9iq1XNM6Tudq7rVO
HrzD91cGNxbC773GCzkERwLGHSY9UUtT/DFf6S2MHPKVMcjvRvYB3M07VAczKxsaMg+74o8OYmEW
ZfM5KU5jjXqCMXDIcSfajiYu22lZ/pMqPP5r0q5LzxKK5fOhUjCbYht9toLr7HincrB4NDOHfo4K
ONHrXC/26+4J9v0LNS6v4PrTc5HPbc0ItLi3Fn+P/drOoz4uA8P9gahwjv6NnCZM4OORzqYNIhfD
nB4pHGO6B4iMinz9L/EWF9+adAv45bEA6cGIXIuNR5Z4v+BS1hbx3ZS+Lg7CrdqKTsuqHleEZbrx
zROWGQYzFjqU4Ba4osC6cHXEPvZ2Fd/8tgh/MJ1Nn4xE811ue+H3lUF9HNx0sCV/vRDXf3TkqdSV
75K+OUG/4iw8Zd38pALX2CoXHVofB3/wNUMPqG6ZQyr0W4N6bygEM44tenLZ3gNTxDNGmNL45WZV
jris4cyfkY6ReswEwYHr9eyDLiyp/ZeZ4ZhZkVvIrVwbg7jCiiU4rgjK/EfD29OfxiLZaWF5FhBQ
WNLri17a8IofaIFCYMxleB4jELbThnqXeyaOXHurfaUV8EO/jtdRtVgB8rqyaJ2lawekQ3Lj3RHl
HvdmFg0G94Y8efD9Arminpqh5i7g0kJoYEVzSbcuDysT0nTwgi3jdF79EFWixVOcFV8wEdK0w82y
qaaQL0Eu7IE7+dwebGgax8BDb+Tb2yI780mgHB8B5Ogg8MbqMMbQIMz7mda4u3mY4k5PMOnFlwIZ
wHDO4s1DN7/IlOwCbziiuw5Vqr2HQOBt8A4U1mfZ7vQCezSPyFk7YKEqbZtZ0sRn9mueMh9VwJxB
c93TASq/XwrdnnWKv3LlH8aH7JPb/Ko7n0YjyfLxx54mE8paZ+r0Fm45n1nb5VO09vm/RHXeG8qc
7IVAZiQH04Lo754PA/5lu3AYqindDerzOcfaiTHA/VmzORm/Wz35E7nJLiTiK+2a5AXOIhL46klP
hrAtDQ7FdwNUHccOjjlAlY/k+Kz9JTm+ihz8tgSBal3prRGmp308bcNlSY/kU8DTKSqV6HZ+/JDU
/AIZl0Mlj7ldqmhUzSthFnT0kpN1D1/C2Y8SZsrL2C7Lm1AJmxqJg1O8rmsD3usWv/5OvT/yCy3o
UZ9kPQHN6YU3vMqOsfefxixyt+hYGiS3bh1ptdsVfJnfvPe+Z9mhmTz7lh0as0dx/XOFELohct8S
9BocYXdNfLmg+de9ffO8eCWxLgfy+DmukWZemWb8+LC19YLHJqUSA2X07rOs3YjUK9UDX+TEmskl
CkJt7yUl7gt0TP5HJ4gc74Z82X7OSCnEaU5i3q4QmfF+a3Um2ZjOFmc+q4WV5sdQuEV8y+Jd7Be+
25EyuEbeu1nmLD13DXW4moc1sfe7Ig8pQ+IRR4872x0GTZaO2Hhsk6woQREOc8n6ukgvpu3VByzT
Fz+zKch/j1tIRI46xuiLJ/XyPZ49Iqxn+KnuPKY1GVVbe+Sfl6nvuG+pNPoypF3gsc/eYDmFjmOC
pR3zPqo/octsl9NqcpzLaDuS+Q1SJcVyT9GIVtmeNh633QSuvTrp/9xiI166RURBOUcOqHEYGNc+
hcUx6dPUkAB3CnaPrNFiXPPw9LH5MYNgWP0e7mM4V8hE6i9ELUCeatG2DVcChezMZCwfZLbmXGpx
AwpNX8VCBnDy8G30p/Uv/XNvn1SvwWyy3Wz52dOhEnctT+Hfmkx9/zP2WQ8Bk6LynMy2g1ZEWnOF
FpN32NOSNGI9p2Jp+l88QOIgWybU7WTZiMcMl9tYntIo7n+RoRI++7tvfyLF7ZMqJ2lUVXNgkqU6
Fj/9tdloTi4rlbNlMExn72vQfyzNwUBzS4+qLtzviHWG535CcvZb6856dwviaP+EbK+dHzpsBo+3
o4HRrNq0A1WA7AUPPrNUI4c70OR6+UsbFPuXNU9teN9bO07PXqCJ2dD22KPSRDssSaJ1FCB4COo+
elhdstQndIJbil3OauLXZLIxLh8dReB2cC+YKm/2FkneFBpx1cey9xcRL/NwS5ZGZveGK9q7AyOG
Bw3UDB2fBvEanLgdhX9pwo/Mk4ZhDMwjb9bXdimY1v0knt93MZEJNKU5xG+AdOotLdY2OHEZDnio
hmy5o7AQsKKrzGeK+5FOnybnISlPoaDMBSV2wKeuHer4UCiLzu6IKBpw4ma8zpok2UeOY9ac7coc
XzUBQHhJbpgXX6mDx1ZJ1mm9W+EHiPlWxGF8vf20VY2/ez/xdJjfBr3q7XOxDFF8Vrtf/04XhCft
kBCksI+1+NvYuI7KZo3a9slmzgOQYUVLPIY4JP8G2Sh+G5UxAvfWT/LXgWnfR3GCsK2/9rBmKI0h
DLe3mn0oFBlCLrSfSWJ5F4+s9i9LuzpxtyeogKlTvthPvo5mdxn2hXwT369J3Qj3PJxe4mwQ7WnT
y4eMr0uzJf8Ze8wKHNLBfdvV2hPQF2h073k9FcGjSQ/YHzseLnqqY3QwlyALDxoNfPtMNp1Hdi3m
DaHPgM4NFGy0k7gmrUsmdA0qmMADiC3A7BFyjn/JQ2s8yiL2noIAWLbh7Q0StpLho6cvEuZxvEgA
gaOalzqkNhSy/9ty3kSVQzpP7zrJWvwE2Idg7PC7PfqV9dHCRlAR7eyxJaAqGFks4gB5pgvbd6N/
T/Bg/woXj2wThjgcvnrWjY0oJy8nnLmenP7Sd6tf0H57oaceVr/vKU5DM33TrL9BGxlf/Tgma75o
323Ra2GbebtCW47fQy23uDJy3f0yGccg/U5U64R0tEXOS4aVlRy9Y58BETvaqLDabeLyS5TjiMGy
Tnaoi3WLfQhjzeCDTu0jogeMKmBYbsFmNuyI1Z94OoCM11ytw4wpl4zkednz492JIn+RbCtpOuWw
y558gEp5X8f12jyaUHT5GRlX2z/Fvh6bz2SHHREZUU3RSqQMNFYOBaWy+WeHxtl8hRkPfiw+3NAZ
Mw9vOIsVsQsFWmRcsSALe9mMGwYiY5CIL9jO9eZmAmTWEDzWyueoDj8Wbti+2xn9iME514P3kWk4
iO4PzLoPsIdqYCteUo1r3NuQ4xxZcQa5WdBX5z8Io5Ff+gx2h1UaKQFkmVyDy9IXKeeoFmtYoYRd
H9WeMbcuKpafEEB/7FjbJdzLMHDJD535h3yB/6RvsjguN6csWORPEKuI+wsWEvHPlihWJwIgd5N2
RVcmR5uyNDF+KJz9NtjzRwQJkGzDli3/k3Zmy20rSbd+IkRgBuqWACmSEicNlq0bhC3bmOcZT38+
+EScX4J0xOj+bzp278HFQk2ZK9daCT2K9IsuRHEYC17kguK/Z/BP/wL8+jR0BT/KN6EJV4l4A6Y9
91ejlC4KUCU9eEoSKOuQWBcWjJ10sCITWUv7k0+sGO56K5raG1nOqpeoIIN3zUkbOzJ+hU5JVhSU
fwZjMF8CuSy4IDIlcqLOjs+519vfFbQgL5YUVTARfbqgu4pl14abtTlC0UrJ45eqbyXlNjQUhBJw
2cNurfqi3sV9Y9CXDrKccac1fdh+jyqj9VYcXkuhP5PuVa5lhlCcW12C/lsIDWv+KEs0auHlYD8T
UOfVykSVgN2T5yNMg/IPIVJ448AKWa03zKKNMVjx6Ym0urgxSgcdeCMTnhvV6BZ1qvQ/2loDGEzS
fPC3tl7oqEfFLL2jjEQo79Cssg9QQo70wlRhcV+Miq5Q4BRNC7qaNK/ZYFsIbgwwUIAmdDTTHyKl
4dtAma3d+EVBILrxLQi02YosqndVM6BNnkxmR9qtx0OL4suz8OUs80x16aKBziLTg/QhF2ZAP1KP
BiVO00Ul/v1KJ+UQNrzsgoKTzSbUTqaFo+/ZriyVwQOtDnTpdlJTpXKjofXGY20GKVFvVQjdFcD7
PsGXyV3FoYDdUVVK82z4UW06rUWtz8OzpqM2Zw/PdBMM+udpmIChK9UMW7hd8zbt/Vj/A1DDOkSI
ML2t3LYlUTfHmlUaJk11KBsarKTeVTcUcmi+YZW6hOlGP0Mb3jQHSaWvodmtBfVMGPWhfDuGAo27
mob6Y+mXpYceSIWJY/p+DZLmS1LrjlPbPlLyzSDlJIgQQP5Djw6tatXfNnCQAUT5kify8vhkNh6a
IjCoPHUMSLPt2p4iGeVlPculDUmmmBui+dRXFDTVW1CR9qWLla5fDV00HlLSvZCnz/OGm6ybOZvU
n+XLIPNRjl1DrWJHQa0rcAuss1fY83QJCw0jO/IBowF8DnIrBZBQqzaKiHMqDJ2uoDCC14hIIp+q
cy21ReL6SU6uLwl+xNrQK/unprXoDQBBoaGnutoShPu40N6Z8YT4m+OQlvASZm5nL6UkjrKdyQh5
YQk6AJri2aQrz69MjnL+P3j2c5PI8h0JbDg5OfWmb75HsOzo/ZSjHWi9+FKjYlNWNrRF8F1guRV8
cpAVHiVIvwUA8yu3b+lvoNKjGWRJBm0zhN6grAwtGTnvtPmkxYngljqEk9yc/VAaz4GqZLJLcTot
b8xUDH/TEknKKjIaKoe0r2mfqGAUT2iQeKZsLYmNrVJDw7+tqFm+prGHbGGKtc5YB2YQ3+Ov2pHs
l1p7NAoK9DMRoKXcUZfpgz5UibrGLg3qpD8NEdL1tkeSl829vczCsEj7Fc3LMq7gsBAH7mAJ9pdn
qPB9KKqHxYsOIQkrHGQ+dfQzhBIJY5Edke4VXSp7tzIMgXLEp/HCRZbJwM96mdnVnrur+4v9gF7e
kWK1wU2ZGtnzEPmSAcEryuvHqNBzaRNm9EIOQSZ5W0OZhWUisOo6GVAETwENEkIR6ZTySFAb/VZB
FFmid0oGvV+nGRjmtyk1/HM/UNK7A+SU72PZTqrbSNDZft1o9HQ79lZtVLdeps3M7FYowToZiNtR
IsXTKzpiKkdkOIQ0JICUnCkR+z/smqiJf8Mz/moWiO5KkhPUBjb/TQIMButwW029LZwsUb0TLlNh
u+4GUV96aVC0nUGdWPnuVZ72qDdR/XPSlb6Ep9QWwUpPCpJVqAqisaBOpDE9r9pYSP7WsmD77Co5
kadb5DC5fUFkPT5oWQwVYohKBPhzSNbs68IKBpYxQeeH3IM62pBEtuRGRVXCoAx7zVurcspjAZHK
21Ik6J4aNdOeAV0iWt+2TYTDem3atuMHfvUy2bYGy7uTR3mF6iP8WU2i+SGyWOIADnSFQ5NcW79V
IiQKiDUIjgM/euieeyluKeK13Iobaj6aflcrAxkxoqLmLkH9ikZO+FxHpO+xK8Z80Fe+ncKZ7oAg
ct6EieJgq+kysglsMs2NLhPhX0TfC3G2kA1B87N6/14CL+xOg9kLXBo0kpoMvF2CcYui08OfSsqg
06SoVBtHLvNK2+paAAktJpuw3JGSnnBK3a8fs9joENC16ISo+VreutM1Wd+VdV5QrAms6kdRSXV9
06UJYtagpdWgUoWmye3tZSX0fK9+IdySfxTdJFOJzoocqDXS0q0C0jvr2Kp0DSZh1JyfYaI/ZaSS
wbW6Gmz7hMtijyjeg+AexlL/nWgnxX+JMld4jKHONH9I4DLcNBIPl6AV6Ghi8a4H47FARvCtVxvY
s1lDLLHSVLUvH0Zd6BD6Jkil/FzbSL4Rk7bhDpOv7nccoFBaQVUquR8KS/thZNJ4jOWRTZiHeRFv
urItnoZoSB+sMJkAI/pyfGl5rH93EFTMWSnVnrMglAoXs+5Rhd4vQ+u17MF4MLwREqFR2dpzEhTz
VTBaXuqgussS1oNQz+kLyJWrsGyw1Gl0CGGu4Hdaq5G76JuB6wRcqyr0vzVeEIcPGkwuKv/cq8lD
qQ7BU5zawwhZsWnP4MJVwVacUNO0vmx3W0pBQPCG36TGRlbQ664KoMc/1kic6dbaFB2b0UOii+Ss
huuCNu4xwYzOg6Sr4uHSpsaIymYMk5dmKmwUl70EX5Wn8afM8a5cWKTZiwXyjg0VYsTORc2BmUHW
y5ZDcbp/xipu1BEjRtEJ434R7zqbpm03DSHmAVYE7cNTcsyVUUwRPquYeDyj8eqqDV7FfnnjwXfy
YYrXcflz4h0nBqPr+AMZph04qZZB7pfDurrAOhnCPYwln79t9kO2M3GZye+mJG23tPCu2CUUk0L2
rm7ChKYk8IyFP0tg1U13jKdcf6lUWKcrS/Zb3HSrHpBbEih6oBKZ8KUAhetHnfT8FalH2tykXqX8
xcGjVNcDTaBoD0R1vlz5nT+vRquGUOxxN5taanvyZKAWKQpKu2Wh5ppjxcWIjzoTkI4W7UW/AY1R
9PG9Pnvm0s2OAzGB7IDQ2kRLddjS+04PwldugFZZoQobxN2IdQWlYjUSe5Bi5P5wYdP4XscWoGOa
OThg1TY2YaKI+4Olw8viyiuwEw1LQir6JSZcOF1i1OZTh0Fb8BPdih/cZGYX3UGc0gTIIhZHbFpY
GQVQ5bAFVinLbR20+CoYNGLlTKsRzbVGXbZUZyqsHnGAkYnfM7fq0FE/kG+m2u4NAvZyrG5nFPln
SAP7GHKCpT3F9L0GNR/6wD7lSl+X99SpEJml9uxtIIWxUh0TLWvidWtlxvcm8kfch4nOTh41J2J5
KE/fC2VE1dKp2US5XArHzJGTkRRZdHEH9p/7SQZmNLM2wN/ZCBwF2lEmclcR71vlqByzevJPWPhE
d61iIsReccFV8UOKbk8cTavPFKK0JkL67ci6LCnyETsW0ohNHpWGZ8PqbY3615Sasla54LbQZVep
rVv9sGn7ppPaC3x8pVTO9tgisLpRAjVMEfUgCEz9ezFisVDe2hqkYDJF8i3NX5tI6g0LhQry8HBn
JqYtJUCqSiIRp1ZB+dMsTPqp2i18JzcOuwJlemZa3ib06KOTuXmlqviTRjbRN1ZQnZz9LWq/hJNJ
vbrvD1JOt/MHSOqTvVbzvifykkN8FLS8sbxVqynjHw0Xl3w/eQQcFBf0InvsQy8t9gE3oeG2tKF4
Ebg4yeeaSv4s1+aSt39LXdr7Z9UaBTUbW40FVpVDmLS7WEqt6SbT+iajU5rZAbn0fur/nEazSndj
0QfatgHt9A+ixwV0j/0fd6ZaT0Hq9nJkDQ8NZ9qDS0YzSMQZWCJ8K1s1mm5rOza8AxIjBFcqCSoy
Lqqh0CAUTn+jrqDioctaZZwug7gVDcka5KOS7gFP0O4MMaXbvYTX5rCSMYLh9EyYFGBolEDL8Rsx
8sdSRO9WZN79DPGVob7u0wwynFCUM26+MdT6dlAmtMSCAgGMi+jJ6Crzp4qKhvei6MW9UkxZ7RYq
YOdIaRG1UJJGRDa8OxmJuPCMVWx541n3DL07UZriDeNE6k+1Zqf0ROeMHzup63A8YLnFXjIq8ToE
pf8r5gNM6wBiuAzQALKzbiuzfk2DnvCx10MgUCulfuRpPX9m6E090jldnX4Uky95WzUupGpL+W74
1mVWv8lMU61vmtobumM2VHiv2PAJHjoBxAdtAinwdvAKZKf4APXsFSvGBrVjBx6nnBf2NrCg/kCb
5HbAOijy1hS6q+2UTk25zpsyvx/Hf++dpgxPpUYRDhJ9QBUTBU1mOgHjWk7QC2UAIzdixCZlqw9b
L4+DZ1xHaL5ptKm4Q8+K5UmvJ/k60RXDWsG0gKUaGpDRV0C3bb7lei+4s/QOC6ApCC6AXUq1Im0H
qKtlMrAZuFK0dY0U84ESPqVprUyk0xgEQLaVn6Jd9zrR/u17syE95QAV6wg+Bak6SHEOPIgw7eij
EfVwfsiVdjeAodzaUwNpesgzyBY1Rj7qbasVNjRrv4Y7IVOaLTlQ6RCtA62omZrvNdOdagGDok6v
vM7pa1Bp7EWUiYSkxof4nFTaEN7YtR3MOq2ylO/UDmEBpQMJ3K6ohm5w5ZSMyyH/leFOjBFcLCuv
UZT4HU4LVOSilV+rtCJWY7//A4Ge3M+DcIpbZmC1+k1eWz5KEt7rmxyP0WmNTZhxH5SYJrizoddF
7m1K3K3nkTjBz2OfJfDdnhqv1CkWi7p2LR2sGeqcXF1wgAnBszBrqO4sHMe+jXk/eMdc4VDb8li5
saq23Y9Ro+QNjj6KiLiXej3nmzotelmcQeE3Vp1YUdaRMwd3TBxelAgocg3nBI6rhscAhAtSMwXJ
ZmU8F3Pa43oGhsH8YrNId0KfaMEuW8ieKdwaD1Yhjy7a8o4W3lWymSC6+vDozeY3Kn64OwhEwN8x
7CPZmIB95TVZvHzCb0bMgmXqpCsQyBjJOhpuZS0hc8K7Ax4yHEI4E6hLi4lCu5pWyXOc9ol3ayeJ
NMDxTmQ3jUz8AoRi89eiMPA7641+OpQk7a85MgO06lIf3QdTZaho6VDHrGAgtxp1SrjFm0ihws8+
E/VtLiueSgsUUWX3he6Do2RyVv/NlK74lQMN8wuqzCZJBzEYf3VGWllrW5TDKQXa6ldh5mnijylL
lJA0avM3vhIL+jiNSvOAi4RZIB23aROP70qWwhQotf2gV9RQ6swI/F1u1vbkCkpQxdpuVRrs2LDu
b5XZaWg95kF34mLt4jWFJlhoCteBdDO3cNOORdqO/S1KAAQTPRYkyq4MkYgJkmp4gHJd/zItSwx3
6EaEeQa/FjryWK1zrUHgKNVJCUcOsWEgRVszbdGChboV/EQxEMEIrkXfnAJ/MGuWZ4DqFdWtuWkK
VLknHN/V/iB33kDBBEFLGG/gMdhs3D5GGaggAn4NwYB/CjQXZ3hDsL0JKDoLnyCB5JG/VvODhbRB
2pG1dCry4CZP1iVVqBxLCIQ0gBIhHLWVRywlOYJmY/GmSkicOFkhVUEnrDRJdc3Es709txyWnoYm
zSQiXPawo+mmvj1DyMfRnI1f2Hia+BOMv8YxQr3VTn4tZVBYEBSHPY9agDajchQu6/QeDGhCokkP
MmPTN8LPt8KI0SdSbGu1zYRJp3479hTdZiRY5evw/LqkplPghInS/O7bUjunOgbXiSNaUJ7DSAdA
vKgyU/a4Mv2xKW8h2aT6dwVHCYrAhiT1FyCqoAIPisIIykhhD7YbQXeBDaNSHgQbxFgl+xZanfma
cNHA/tCoUVhTp1Pv6U1cIKG0WYnbV9DQYYNTeN2kRdx4u6Q3O+sGs56qvhE9AQsPIhwO4chRFRdw
nU2BteZQRe0+z1JEyUFXaYdh8GVfgFIHivZryvTqTs1A979bELqUcwP1EJ+vaWzs+6hoSu9OoJUE
vSgkCcP0iWFuSnS30ndFr7u8XmHQ4T8kFnj/VpQVxXzULyr0O1TisZ66queXl0ZqMnXXgi3YeDCp
6kOkhj6e8LJKcF3GPcweaVZElorfyHsJjk28GxBt+xsuZIgBTaWQZoqqwWwgtezghQxzqG8w0GzP
nWqV9TrszbaDp9xI/g5tsS87RZePiLpQISjSrQ16j22XJwLv4sWF+hoVkl/uCrssbKjpgjQEia/5
wp3S4DDUUK3Dz8m3uxi0wdJsqmc1nJjyez7xAhbo6NIg3gdBJDcvtkzADTiAEn6dh2OpHQ086oJt
HkFFoFUF/lErAySPVsFJ5MfPWLX0/kzSNeT7vKyL/KRQ8MjdStPr+lyLEr7bxJrJO4RCPkG7Khla
+ai3hUmNuq1BPbo+Cgc3rQM9PYObD8NeM+H9SJ1mIgWw9NxDzdZ2OqHiYPQH7Ken37rdGSG83Cb6
9bVHqDKbgL63WaX/uQyNxJBV3l91YbMad6liQ31qDhCH2/BBTdJ1CgmPAWE3yatJ8h/9Kdm0ubKz
t43jsFJXfJiVz2w9bRV+kUybEPqFLH5CaWZWMQh+Av3tRoyv/TVWIi7EkEO6o3WF42+u9hlQP5s1
fa9nc28NueLCGlViWl1i+e2hT8px3VX0QqngYFEQ7mk0iJAAVoXgWouHst1IpvUjQ7O2k7tAPflo
FLwrtrIfGkkoqoBOqsvUzGer1oWnudHipxPkeXug/rHuxm2U/hH+d4y6riz2R9PheRxs3/nYuP/Y
iy899UqrIk5qD/ZlaB5zZxx21sGQ1o1jKY9hdqhczb9JMWRwcvo6ntJrPVo+Wel348/L8sYsFgQk
UHFZQIP6k5S6aOhtaqzR842/jUO/gVu+pXQSKJtAXPnAyqczB8UU9MlWmfty5lZIUz65aenEUjhT
e5zwzSDb8eUbPAgEL6VRICn4S94J7rwuZs5xsxu1v2ovbYo8vrLlP34HEDhZnpd77jm9bE1aNeg8
O7zLDpR3Tn65oYZ2iMr7r1f700EU2jiwvy1TWW4qirTakKBgOCh6eoHMd6u195H+8F8MQq5KHYDQ
TF02IY8zX2tM3esO+Np+E6byB/X6xQ60K3bZy7lwLIhB0ANaAmDRsBfn1ZRELdtGgZtS+Fwp96r1
ZJdXhljuEIZQZNglpqIYBI2K/H5vKkUn6DGuRieIqEWzrtCTmtsq2UKv+PqTLQ/7cqDFViSGNhqb
sOwUFZcmvo+9v6r4VbWnr0f55Iu9m87iqIV0L5iSSolOdfVLDX/b4jRda9d17YvNDt5vT3MQJxQr
+WKJ7tTtSePxGtcwwM3qyr1xbS6L1S+kwQuGUItOVvjkGUdP/63nV7yyry3K/BPezAUztkEXHZ+r
986Gf2RR5Oh+rP/D07Jc+kWjl6DTUFnJjIKXoJMoOX4/33Xz8r9b+XnZ3kwlRChA8GVEJw3tSSz9
wUYQ5eWV7TV/8rdhw/+dCZGlpsgqJ2cxEwgChVTIZnSa3chWVM72coMS9+uZfLooNtV4g0fRhOb2
fiZkchCaaY1yCoqTjadshOmoEv6u+uLKQB+eh3k6qsEFo1kgKZq2OC1WlylyMMbJKWzugDfC+g6d
/TqEQDgVP0YD2I5CFz6Zm0k9edb3GK9vLbWdgdJMAPlSYAf29dSXturLH7Q4W0Mz6aPk8YOCSV0n
2KCFhkqt13crqUBTR1uV568H/Oxbv/0CizNGMwzPrEGFTp24UX9mOEymNoXNq196XrPlxnk7zuKg
TVYJalr6ySnGxzSFtIzUDnoQtm/iBls9gfYyHjYW4oev5/dvRy4HtjWLV09T4Hkvd2xrx4qMMCQ5
iUw6oZyEUnfGZA8pAAZ+0kN8b/0iVezu0r15l2LbBA5+rePIZ9/Y1m2KcnOwp5uLbxxpgdGOkPdO
hRu060CiqwrSfiO7NtX5BfkwVUMxVSQGBj1+Ft94VGwP1mGTnMrmHsx3hWtaQpam/PBW1kXfYKwF
ly9xrnzgZfcWS6WHE+GMKRNgmaq5uBJiOF4VCNN4VmnbJJPI1thC0Ko56u7N/lHJb0EGIxCb1rqx
1V9DmZzntYABM2ITVmyBPTZGl175VR/eqMWPWlyGTRiOA9Zv47lFeTkOjyFOCAKLsRb4Qsk3X3+C
D5fiPBixtYbBjlBpz/z+vipwATVSjy9g+fdAP6uq+vOfD2Dy589NojBiWmZKYJZwjIxiPPeU8TQN
q27px9cj/Atz3u0d5vB2iMUcpG4wbFLz8Uw8tDLtu0D/zZyPerzuse+mLr7DA6QrxZV1+v+MSyZm
WQYBmFicDUBfPBCzbjzH2bErfmCL6Eqzbk+cJBs7pF9Di+3ktT5vHw4kk+UzWvQKpJc2Iez7BavR
spQU9aezhKl0k6KN4ExCXTnowZUz+dlINMlWyDZplkELkfcj2aXnVb1fymfdx4Idaykv2uEfDlPq
8PUCXhto+R1FNsS6n8jnFnuBI36/EnglDroc3GTXjMJ2/4vxLBWA/l8yYy/e6BFwgYx4kM9qHa+S
5kEQP+GSX6a7r8f58CCq5owR6KoKPmqp6mKpDB9yEsQXGQW8dWqM+KYpH/2ywlpJpz6jnrtcfvh6
RPXj3cGQFrENqARJx/JCSxG313o/ymcrx1810aVftWfaT+lErSfF9+vW0LV8X1O32+v1pPwG7itx
pKfsiWdsfUwjaloToCF2jX6U3g4NNHdc3Iw9ViKrtileGiQvaLONZtvhTLFqqH04Ui8dU9uIdnh7
Bj/QmAdXTtpnH1JDBoMxFjteNRY7ETZNjgJFlc9K/5D9iGLuQWfq3KY6Fle24idnmtwWr0hwFq5D
ZdmSFfhPyutCcLxwD48LZVOY5jqc9po9OAX2OgMinX7C3mka11+v3celm68RupvbXJIWgd3745bX
sUoHj2E6W6a0wf4A+w9p06X7AAJbrb18Pdi/tojv78z3oy0+KTp/hZevm87VK8z05sf0W3mQ92IT
bTxX36m7zscJcSV+pnf+Y/tY7Ksr786/xjcffoBK+k3eahjmv1Zzb0J+XcK7BzbqdO73/j31hFva
RkpH4950p5vi2zE8p3R5Fbt6Gx2gZH09e+VDtKEye12zDSEM/kedb6Q3g8f4IkERtqazX+PehLjq
NjDpzBCl35WU4i9+z3jENb9ypNKIxtxGm77/N79AALSyr1UNkOD9LxhUAzo8xiPnupY4XNU3cNud
N7h9ZOxQqr+gk4aMb9rxqiWu/Xrwz3YaEQ9NuA1ldmdd3Ett6E9RTdn/rGX1o72vLUdk2UM6/bWL
m//VSP924ZvvHFB2R7li/tvT+UpHNE9Bfp9OyU7qkTjZ2bevx/v4ksywEbE6QKfB87hY10yD9yRi
Xz4zw31rehvMoDGFKO7t7spIn14UwL8IfnmMefwXQwE6B5Mup9xJp9LMUX68RvUjHeIi1G6SV6zK
RF6XuXXtfvp0hm+GXewbPAa1NK4YVrLqTdXdhE3lSGZxSCLv0fNUSOXrwK8PflHhFe1i89VK/T4U
8boAna+uNSKfo/LlIea1AaG0DNzZzMVOGtS8y/Fplc9Zn4Q3ohv+0nmo3w4xDgFfr+xne5YMyJCF
Qk8jY7mTUjUzoLMyb50CXDxh1LyFOVn0Twby5a+H+gdlLmf1dqwF2jVVQ1HqSSyfe6NF8EVvGYf6
81aXsidYFcde1SQn0oe7qawuVLVu00l/SJPpLsLOysFpOlrXKWxoA5v9lSWw68oUDTWXfPKxiw6m
5uKHCj6GUjW5OQgi5hYUZjzld2AbNyr8RqdUvbXZ9bCy1frKxf+heEJvZotH1ITsq4J+isXkrJKy
oJ9VBCWqgbOx1hzbuH2WjSly0iSj45OW/cISeZeX+gvFwUNoB/ukylUkxNoWYvZ05W3/mIDwezRe
AMBS2gmLRTBG6AkC7rXyuSGWWPWGGjmQa/Uro3xyXG0CBIP+NxrpHljl+/u2aAWtt2JJOecrnF33
/U3er6MThOCo3OB69/UO+nhI3w+2SGYrRPySpvnq2a4QUBTqXWodJ7qtQd2Wt18P9fnEaB1gUhfS
ZFUsLgQNL0itQNFzRhjSm5vItV6CI05caOWfhv9qYoYmVFUmeBbyYmIwoqewBZHmZJCPYqcY4KAK
0wAtztfT+nix8AUJYbnJBRWvZcSHq1AymSMDTW2NYYtaTjcN/a1u/Fzzr0Tpnw5lymxCgWOKqc7B
55s3SlLGtGhJgM4VBfC/aMZCxw/77NUMzdevJ/XxDmNSczoA108Vsr1cKoypDeEzUgYjA86Gk3R7
+BQpJlp5cqU0oMwB3PtLjMEEbs3CpPMjx/39tOJEj2sal6iwJgpMgaHdWU+0l9rq1mNjvaSwCMLw
GwJILFe3MRJPLbjSqP3jwYYrapKFcF3blAgXeyULkBCWPa1C7BEuOyFO6mZyav4XG4UsztIJZRTI
m4tRcDdTKE336pmgXoYao0MoVDNHvf966T470W+HWbz2eoUWnybO6jlPuAT3UnjB1hUy2NejfBKX
8s3mEIYZse+XNd6ingrJw43uHGl/RsiRUvzY4Kiapds4+QNjaaWn9FmH5H35euDPzsDbcRdfcSzA
3zVrVM8+BVw91W+tfqsUzebrURT1kz35dpjFV9TMQuunVFHPWY6pge1pbk43snVdgf7PtFB6ejTd
jiyoOmLnHe7xnkwPsRWHdyPuBFd+zTzY4oDQvF7oOm8Pz8KymbjeZCj+e986j1B3wBrIfDHYWfmV
pa0xIW7XX09+Pm+L4YRFbi54fljZ5XAeZRQz1vH/66IXDV9xsDLHHy5qwY5tkPb47W1Q1lfO4MdB
hYzW3tBtE3iPNOP9JYCWpkPHFlvnsFS2UraaHhLt3I/KXRzd2+ZemFfG+2SFMavQBaGgRiLLu/5+
QM2LBkiVvTirSrsuMf+ow0sZ77Byx42uWpUdtJP2SdcUx0L0y+Vx5St/ktfCUrbRZM43H3HpvAXf
3OYCDY0d6WNwSdufhjihWV3p0KDgxMWD03bbYMCAkU9OnwMpvUBgnMaDhWwKL6gS37DWTGlP+VsY
5RXM6bMvY9lkJUKjpyg572Lv50inofIo3jlGcwOXSq6JH/cw0zuY8QFNVgGGUBt/NzfhtcbNH9gq
80OALbgyZ9rEU8u27d2kNVBvff/St+q3otoVsdO0GwBGfPAPVjusBd6slYT/lJhu8vRghGdF2vph
feXIffIoQeAgiCc5I2QhEn2/OshvUEkpsX9BNOlqxjd5AlWpHvJXFe7GAQavnPsONjtuX/yw/CvP
70cU6f3gi4e+yIymwzbDv8SZvSlHjM7xWxD6C7bvTgHtT/Gu9f+dd/v7M8/Hxm5f432ShW4uTkM4
ytBiDc2/4N6E8jCE1oaTpNjil3KtTvPJSZ+DC44d1ELdWtZp6OA1jdZo+RfzgK+kHu6y4Wj1YpWY
8Tovf0j2lYN2bbzF1PSIbio0a/MvRTsXozCWye5aWvUh53dxEf367vwIa2oQT+AaAdaQbxPlvt83
kPlUEwuU6DKNR3+b6LvRP+jR344FjKPHVqfKjjN+sRlN/5j0QMiOMrxGLrZMkqNKN0K6rfFD9rBQ
LQvJKfsbpIIBluZJFF5LND6s+fufqi3yGZoq4tAft9El/xb8YMHtc/mnfBrW7S7Zw0Z78uCqX/k8
HyKtxZCLW76nfSz9C/voUvc/NJp7t3++/vwfXsrFn7+4U/GVs2rT48/XO/xG7NJBKVyGP7v2x38+
jq2aoLwm76O2DFntrmqycRqjS9M/61V9tAuupNQcL6HfS1fW6UMszpxsnfNC4Mi7LC+WKSuNvpFi
jzlZaXYjD3mC+2hJDjwV+bYe226H8PNKlPUxV9OgAxFtcB1wGwPRv9/G8khiinfcdGgdupms+xt2
5w7xQ3iVtvbheDIS4Ko2J9QANMuwODVQKoadLx9ArN1hJx1R/27kbXjlVfu4M94Ps3jURmEFaSTR
+LrdD268hbyqXstvP27ueQhBUQNWxRw/vf9mIrRSWdJD+dDsQKdd1Eur2n31z84et6m73//pDnw3
2LIyBF5J57yJzxZvA1c46p2y+3qAj9vu/QCLo5rM8dEo/1uXfo3rzB30gStron68gd6PsTiupSxw
R+oD+WA9IAxJUbUgwLkf7vh8z94pdDxm1rvhGdD72L+Ki7fqd4hQNtZde+WQfXhx/+3C/7d2tvZ+
7Rqa/5ZpH8mHei2oKwhH7EPXujLfj0nTYpR5B70J+XrkNTUeo+wQt19jWLexXf11pa7Asq7M5/NT
9T/zWTx6eJ6lbRcxHwRot5ErOdZF3UrutWE+vSfe7Hl7caxwL0ZunLGC9Ro2jwsgyD2R/exurm1H
5doKLW4kjDGwEe4YybuIbbueDzECk0v8VNyKo7rTnHKjPtP9S7jalUfr2klYRGP0ssdCTWVk1Qmc
4lZb+9e/47XZLe6OqeziEkGXfJg2YpMOW+0X4beT3eorxcGp1DGP4oxXq2hd/+r8Pt+WIJoEZJBZ
iVreb8syi/TQCJJ5W7Zrb5+46q504ZFs6P505Vb5mFzMR+DNWItrRVU9WhHSq+EwL+K4jrfW1nOz
bbDV1rmbrL++wz69X94MtrhfMsPWplk5ddjdb6+9kPN/+y5iXkxkcWNUgFalBhXg0LETw3XKvu/d
Ye2Ql7vh89fz+PyYmaYFewQQgErY+xXCECeVpKyU4ZDHWyxb1sVtfC4OnhNduTeujrS4onQJM/pA
Y6T5gNUrz8UAbJ/tPefaqbo60uKKUvA5lst5Tv2629WrcE086Op31U1+heD66V345uMt7qiCtjSJ
PxbzHTW4ujM/l9Yecdf/9tMtb6isHXPbYEIYI+6GXeQ2K+Wvg6PX/f9yNywuJAxBhBJpTKjaYOSw
qlfiGDuKQ3+pK1O69uUWt1JL2/vMi5lRy6uYIBohBnSai3xlQp9efv+zQMvCildIrWYK5jO48+Or
7ijiO9dunk9ucViBBOwKlxy17MXqQNWnPIrCmUECJ2KQ8S79L47puzEWCzNFOi3I7H9bGqMhd9Ws
VvlO2l17dT/5Xu+GWSxLIeiAhdBkXhZ69zoyjx/tKK6s/cfyG0S7Nx/MXLwKPiYI4RTSw7tcod93
mjs6jboRd3WI8/j/Ie26miO3uewvYhVzeAXJZke20kijeWHNjDTMOfPX74F21+5Gcxv72WW7/KCq
vgRwcXHjORgmyWyTJ1K5talXIpnHASxdKvCmsDDlrD9SuyrYBUDkSe+Izv4Pzy6svXsoB1uIbpDz
QNcYs48SwAGTcjDouzftqvfqMOEWGT9jB7x9nKXdZvvobv4ti+22HsE+alTdl6zcHwDa/DTCGrVI
R4BG7Cg/B2fJLj9kku3FQ/DENbbUbDOv1ZV4ZmdB0tdgOPJLPDXrmYP20a/bXG9Ay2BHiPM4Ror+
4o1ENDuiUxP7i9Zg/P3C15UlXcqA0YfNjQkGzA+Vq5LJBum7DXhjjoVf1VVEq+gLRQJRUzXmoe9a
pN+7NpVOeY4p6whlff1RQwj2fRkftXDf5o8yOpSUF5DkkhEz34ag89a7EmDSgPmvT6C6fbFeKarj
FDCzEp4z2c4cyy9+YcJ6fA+2qKvapi8cA7v8JYocuV8jhOw+X8plHuxl0gRgYkBu6wpngIo3TuyY
9nIcfbyrR/k1tnOgZ4O3zgnO3U+AUjktr4C38kygcGbpiHtRCr3JhgD8BXuPXk/E1hrYfZ3oJX6K
n6iVBdnSJj+Ctg2kY9FT4TckdXiGavVqXYhnnw+hzZBwA/noKTpq5845NUd13x3j7WYj+R7oeX+C
0O3PAtUrPI6Or90qzdJVjHhiuAH/Z85cG0tZnFuc+WPvatv2FOHND7bUjMhEPvDjhK+c3M1pX0hk
TJaoD3OoxJ10ArgemIrd0TaeR4+6NMW2tWcXgSUSNoCtOky70aOBbLBdbAtY7r9BrZiResOPj+QV
VxitLn9tg8a8FIkQY7h4wTZYW+1sPqK6/9jvlw0IYOBsgai++NX+Bhm9V9mgtEBAXyOw4JzEiqd/
9QmMfRuDOAE4Gj5hcjIHtAROeQoe5N1iJ9viBGpqW3jhORRrocyVTMboIFxrdQEM2TiGqiLpVvkK
tDE076BdZXy2tpw10m28c/Zsp4HRKNqomI10+qEcIvjlE5Sssi2HK4h3noxJ6cAWn2ciFqbgOpV+
aws2QGFtoKOMDti0d5x1cW6RxgQCDdBYgoWua3RpXB/Aycj3A5aXPwSwF+E/CkKvTo6JCBBnGU2e
0JPDZaFh6HRsbeOp2M4OetN5XjRXURjXk1LDqEIA5YyOg5P74DL6Or3RARjRvuI9CLztZIzS1FHA
eAMmosdDNOwwpgYiNqdzAFblyrtgG8AICI8aXOzKNqA8YAlHrot7qquPwoVRYCyVGQLHoNFxquDk
/coLAWbKHs7UWKkOUK/t9oHaAcsRuMk8hb61d24K67rqIC0E7RPO13wM9rUPU+iCZNMP3zoHbdLY
9TPSfGe0vG0tEMuSYZ+96o2z2GCrH4ix753Mz3xwt/7DHOCl7umMpQJRumlpA5ShdF9bt0WO88HT
HkXCexZXvVt0DVuSjnkPuNWMkmPKPk36dJRO+mn5bXxZDPAVu6AH2XITuWvO3qUsRsMboR/1FvAn
X2lA6XnajN6wGxxq/4tt+NARw8t8+iwmuNDAjCH3TQhV6dvz/nupjMoDPLwHyQHE93sAYdpIHOPR
S3gNrbxFMhqd6EoQA+UddsqG524X5/iRmkUwGJz/USR0saHskwpbLwFqHrJQdUdedXgJnIG+njg+
maj/LNhDmyVGFtAii+YyRiszJUOCaZb++7YmR/ME3HjYCxzebsB9MDeRe//IVr02uIw68BhUgFrq
zJnloxHmBTgdT+BN/DM58qvS7V5qR/LqozC7wFvaVqdyE51KBJqCp/F81rXDhHUCNIQhA5mP3eB+
Bg5SDiq1k4WbYUJD0fdqAyzLgZfOi07WHu5LWczm1r0pZh3Ap06zh4j9ZNnTU0eK/f8jDqL3jL0I
l5IYlwSogFOrJliVcQZa/M/hxdgmeFDNY/en+Vn49UZFESCw56f7h3nbtkGH8i52kwl+YGeAmjtg
heAFfSz9AT6pdgic5o+xD23lUyQdkEY4MldPEH10tCsKjJ6skQ+CQEobrZfxzglkOJf70MUpepiT
Fg//xMBYF7KYE5QAIRPXSwdt2dJiaPzZ7tDQznFi117MSyHM4Q2a1kgpEAm/7jw1nXDrPQ0O3v2N
44lhzkpr2pGSwdB9S5F7H/aAgyfo4uZc8NX353I51E+5CIibuZJRsB5kFHaHc/uoHEK3RKZq8NS3
mDMvz1sS40F28igbC/i7v2rIYNVuHVAlQ9t5J8RdE/OmxnjjTJTjZbyp1N8PXWqWJzsg0ql+u39M
a/lxzFj9rd/Mm5qCJrOUQiyqcTBs48duhPJCtIXz9i8VgrHEZbEAaYkqN/D6jzQnRe0+FsUzg/QU
bozTxYKY97MspVanZJJ4pemblm7Vn7NPg1SgKTqA1neW0rM+/t0uGkxsqgyB1LURhNKSq4jETG4v
e0D42QHHHn2NgTHLA1SLqCBVbYIXgO2ZNnJAIGfqLKNMOPrpFs0MR8X53aELYHQwG/7zGy6aWz8/
h87jI29rVxygK9nMEbZA1swxGCGfDt+rB9lNDwsBKLc92BCs2YCvdfNN5vH2llqKeytmDrQzaqWS
J6x4OaLsC8BcJO/BgHPMHyZfh5OpvHAOcyXHdrlMNtPTAtlO1jIs0yAnyQkP1ea8e3Arv334tv3g
7OmKTbmSxZj8ZEH/s5pgcb0LulgEbOkxIf1W41y+NT/oSg5j9a1pigHIizV9B3r4u2gLaAtYdrtP
NPqS93d5A7hN8PpBXXmtaurK6UlfTT66gU5/ts2zjdNOtqYam6n2fl4339Is9TgHtvJGyxK6l1RM
K2DaTaXfcPEGxOj7kZS5pVf+v8su6ak6dD6t0nObK9bX87cs5hEAxLcCnGUqy/5KwUYE2NfUs6Op
J9RkHUvgBllrColeVdoobaHfT2TW18dz0/dSI58SvcUIpCuI70b+Rze4oBNrgmQRrbHomlQorNr1
RvZ5n+ZSoson1RsQyaOKieTa7gndsa68Qa7REfGEcw5vzahcymQWp6UqKGAyyJTOwWP+1L8WO9FV
nBcwJtmNW7xmfv7S+Yo7bu8LXjvIS7nMQSIUKQVQDcknwIyCsWHTap/3Bay5q5gL+ns3mWcclDGh
oaaQIACMkQIiG05QHcQA3CylWwx+O3hN9asvhF2lvZm104D9l9d/vmZfLr+Bed6BoCkVHSYMTqId
7NPDr9QNXfFE3yegd8KMjg7KGGDcRLcJ7+av9dJcrZ95Lga5B5/coMgncMW6qT/slKOEkeaBDCQj
ABGeHX2juI0Nc/fC2XqeUjFvhipVMoYI6Ev16/QLyLTk5cnzHlAYmLznkfCqUGvVkcuVflnfCwOU
l1AkkMsg9LJ1b3F+1eT8I3N2wETB46jjZW5oPH0Yyce/3eSvT7sQHXWAppZmbDLYnFCnFciyO794
DzQL8hMESkjePvLSBhyd+krUX4hUG9mYUD6l5naEyGQDZFFk23kRxC2gE4BIgbZBMQAwaqSwSIdG
I8QgitKo/oBKIjkOm/PmHJPPz8ZtXHA1/QztPxy9oc8g62tcimSeSaUDEHocYjdRq0V7Rbmvkebp
9s2Tvq1sbkVr1QRdLJAxt2BE6/qoxgKjCBnpzekl/Loa8nfxt7YXnMq5vzqeOPr3i3OTVcGI8xji
tLQki+irZcKR8PWa39s/xqhaQwLaieB/tFG1VTd2SxvnRW9Atm3sPyAi4shcveqYYrXAt6ZiuICx
cAJSLMAN0OVT8T0EMeHgVG9ou60VF+zB9/dvVe8vJDH2LO3L0VJqSFJATrPYuoacR4w38Xf/EfOe
4tWX+EIWY8BEvWkaoALjdQL8+/FpBF4zJ5rl7BsbsrRtuKgY6ZRPYNbEsM+cEqAEWSQEpifPSHE2
jgXu1OIw04zIoPFsnJP2BEaIaiZKaM9bUFLeP6S1gBZmw9QtC8Cc0s1gs5IBmLjUEuWUJ8FmiI6Y
KLKGYhMsJVjhPqzYN8XOUap8w5G7FqZcymVUX2/HwspNyG1r1MV1wHeHdo2p9o2Jf5CyPoNkhqP6
ayUfGX2xIsbLMEEHJL/rG62BXKeS0kg5jbObb0e8NCq8pvY3qK1VQB+crHeeyNWjBLrt1+AURpYY
vWyTulH7JFVOQLA3MyKqTqGR+GN+ScA8xDvKNb8euDPoFdXgwWNK+Hp5ZdyaWV9Uyqn/Ez7l22Er
+Io/vaYv6UY1OMJWF/aXLAxDXMsCC/GigUoTW6kB559ILzr4Y1/Cj9Ixf93XFGqQbmzkhSQm5BNC
FThOIySBr0sbNu3v6U8FmlGZp5BU4e7Jka9XlKoNYMCpHPC6nuIfCFPAEgT2vsFOH+Zt8639ZYAQ
k+jf7i+Pt5GMTraNGJiLkoNXJ7eTuAAJwido8zpzV0dHITnU5du/k8e8apGsilWQYZngyAQIvFht
DPR/PCRPzV54+HeimCsuxlZWTwn0kUINpsgEB6Cpf8HoVOn+O0H0dbh4qQNhEAHEXn6tyXyV3tBL
BCg64VEKbek/TzojMEevIvBKkFfCLOK1rGhc0oziUJymzrSTFARZWeXK1TmLQdlcgw245inmraVE
7kpFjx1G1NEV95X+vFhdWieVKQGr8qSBTVRoUA4NzF0hGWSce6fAvTOKPchuiJCkRGoAgiaA3VWN
ORf+9npcfwVzPTBK1YflkgcnQ/6cU68szrXh3T9GngjmKgiyAWqnOQtOIIzbJNnOGvejygs+VoWg
3RQAqyIAIliEM4w5z8CmGIJTG7ZkqB66+thb/3GWypDwqMoanZ2WgBV7rSOqNgtStiyRb6Z77bt0
rhRXTD5a65wVOmkbTtBKb+y14bqWxhjIuWwW1LalyA+V0LL7HKydQgsSifuHsxKe0hlglJOQS8WS
2DRfNGJUqzJiUMstxS4vn4G3laEsl5G5nsG9+Jo3IQElpwsCv2bZjUoNvq2K8pGdQbHlJjqqpDMv
tKIX+3rp19/ELL2WK6FLxzDxE9Xa18WzMlq7MHscCp72304eYx6dwpaIqoFcD2Yyro806zFcpo5p
4ptx59TGW1WUdgQnM0Q5CH0CkS/HZPq0NI4JXWktMyU0atLxDMxTWxqzQgW9vh2YRTMfDTHebOcu
QUeMk2xCL3QlR3Bbx3TQBEQaD+wwTkRiT9+kTrf5Jn2Y/n0NUFZ2++pbGBOwWEmXmMOANgwZVDIP
CxoI0bymKwCV7w+D9EtKC7v4UDQvMUETiHQNJmSFbAs2dln4jobT9AdIq8z+IAjuiDmr5C0DalgE
8h9Mj50bUJDXZ9ASZj+UBhBmtim+WaBDvr+G27sCKFoKPKOIgG/ErOj1MSaAhZDrRs/8Ois/TKCh
qmAguy/i1sBci2BOLKowyd1lBlpVgDlbYuZAd+aGVyi/fROuhTBHoRpDCOYMCBE97XfvLR0BNyQw
aJXT4oJ7DzwicuXOPKePtzTGQCtDrM3yDKma4KTioY1dWeaEWSvFPBgZBfV/RKeIUFnbKY5hqAVt
W/pCU29aA7BEzyqG30EZChI9J9N2IPghY5t6EQ8+/tbRvJbMHFwwTr2ylF0JLMrnH0oJADT0OEB9
R5mjhCsx17Uk5vRaAAoWVdiXPlhIDZRMTLdOSAxgSNPrTjMZI44LsboytNOjAgaUYpiSa62vlDxP
LLCX+bn6LnQNGQwB+vFegyQslnkO0oqVUOEi/SWMsZTipOaglq+wOBDcgNNR6X8apQe6EU40d6OM
GpQE5QtZA5itCYzZ60UNahUBdzqxfDHbd/OyrynwC+chvz0pRgizc61ioAdSiSxf1dDAqxwB39Ma
FpE72SuSxwm02sHHLFSv903I7SWgYuFmog8HeKwiW1goROCOgL3U8sfCL2UwVyN8xO0jza4HMFxj
bMYIyfAwxjT9C0f06rZeiGa2FRy1nWUKjeU3yHpN6bdHJDsk1E3hewaJVzjmhwWjbw4bo3QFbiKa
3rGrB/1r4bj2QIHButnslKHGZp+B781XpaIH3+xn0m/akyKDtSsjxWJLoq2E4beWC/D2BVTNSgYO
PhxtOqtgmcydBMR018RFa/l4qJ5eIltCrfa3Yet4XwV7IgtBOO2G5AdAldBbENte8+TMB8sZSYG8
jJ2anDt7k2/CTlx+D2Nrkxos8iH9Hv2bNqrg/bVl3R3A8yrJ71wqiNtmcSqNInoC/EORbuDTAdXS
l7rZ4TKZoxvELZFizavF72NgbRpwzprNJlDBgyuZdoNeRVQjJuVkgISU5Bo63GNH7D/EZmMACm8I
f5etZ8QcT4jq3c354L4DzQ2tcABau77uKL6loR4tmODQ9YdIiEJAjYdP95X/xk7SXQDaCqDqdWQV
WJC/Usq6FuhGlm+hP74FSXoyPbUlKj+7IZbt+7Ju/WkqDAxU4JYFpA/iuusFIbgsTbx1uGitYqfS
DliJ4YjGBLMkLYrLCTjnFOEspl4M3C5BnmxT9wDK/BhNqduaQHwyX8J55jxNdBdvdhnPL4aigF+s
sO2patZEqgGyWT9QNjqaxQYgocg7+KCc1fPk0JO4iGl7uWmXWhQsHzyXpzYutlYk79WAdAnHaeUJ
YpLQcRNpUtJA0Dy5mgWWYC8ClzTnmVjVzYtdYxJvsVTmldVGga8P6U8TdN5k6tpvHH2hrumdo2ET
D+oyqyng3Sx/AS3pCOAhL4TefPttYKKqf5iNzX15MjUwN/JM4CdCTQFvqDD6qRmJmAHbMPBTUEWI
tkWiFzSE2i15QaGuIyq6h3UUJo/G3h/854/70tduIuC6cRsRcMIwMdY4U0FDWYNYwDe0iFD62j4m
SvEmtjKJBk4L8dqLdymLsbRdO0ugNy4Cvxs9Q/1R54+1xhGxZsw1kfKPUQMGTMFrdY/bIAO/PZYT
Tc8GIDtAit5Ph0DZScpe553cTUYRhoXyyiHnDPQWi0U8AfGwFFVLG/joPjrCObGNzHCESPjUkV5s
TPkoj7+bkRORcISyyCdd3MWVDhxAv58LItXRVrcOjWiRiqKDg6+dgHrSjuRo4BisVblIsSDnrePh
ZjkUAlyJMm2awAds1L6rcMHJMtuBhHk6rd/eV8pVRbmQRf9+abTUosoTERsbgnY7fTHVj1rgWJJV
h5OmjP53PdSeXcjIgzYUVLAF+xp6V/K9vGtcFRg8848kPSWLW4ZcLHN6ldh7fimRMcWK0hlWKUOi
HkznoQMulkFEE/Ce0yksn6r5qRQPqS4dpzHfgNKZs6e3iRWqrRSXXwHEBYITxnaWuV4tcw7xZoI8
gKS7c/6rkn4C9MyqnqV8a3UKERWSpfsU1MfF0/0jXbUzf0v/Oo6L7V6WJJvHqgt89LyTWixdbTK2
xggeRuBycN68tVcC2Lf4F/B18LPo3y9kJY1apFKYBH4WOaAIj7z7S1m9CTQjjQYAEEex7wOwlCyt
12DGYnhzttG1zhSDax6ke94wuNP3jvLuSByhtxVsenz0p5EQxJawDkM71pZZ5RK0J+7sMvd0Ffxb
22lxsgry6u+duQEgdRz+iDsCdOHSrus39GZxtvZ21Jj5DEaJRbE0UqAm47HqFVLmwGF8Xir07swb
zZucurQD1KhkgdTYFYGjQ2vGHZirYDpBDpB6ctfn2ppxOJUxjPucbLv0HS1pRAFZOXDFW0yPaznH
4q3eGIo4htY2+MLgmLiWBz6aAoT1OGikn+1Jz78N6g7kNGqg22Vx7LoYzA8IFUVgthsaSo67gke4
srpilIxlYBJitJrFqCtAQy4KC4w9AO5tKdlYlVfph6B2ZPlo8tAn16wucq5/CWPeThPIk6MmUWHL
N0Cah82pC3lw0beVYejPpRBqJC/uppktcwiKeewpkroNpTH/kSm930hvlAdXGsNtjsQe6cdlA5ae
Ysp494geGmuFoTzYT8y9YDCfMYNBr7RZlBuBn4ypDXLBJawdDeFVSVsZ8kM3bPrsl1mditjayvHG
EF7/c+txIZ99vxPkISQj0wOk3dysRbA5ZU+1PYsbwDs9iwj+uS0bq3cW1GC4OhbqZQg7r/d8FpME
5JMW7s2oe3nqa/LvpXlrgoNYZl6gjjBdhpNmttT9qsPExTD5SUe36P11r6Za4OPCdaAJRwR+118h
d2JXiVMOhLsQOKbzc9TvzHohM8iAw66yywmzhy1GtJXER6/8M0f6itE2RQCrAuMaQSDKRYx0c6xb
2HTBT47xz2UzATpGQLoFB1DbwI/xzF3sCrkrA8PZrre8uGXN28CUPBBWLApghLrXtfioH9smRaMT
VXs9S50o3uTq0+CmZyulY20yJ4j/PwSiIUJDmkVCnvBa4BQYIInPZMFvDdHuasGV0N05o/bdAs7Z
M6o/ojWCdpp3u+g6mNuFdf4tlhq0i+st5ZJa4fQEv8yeJ+lBRv9qamD8vAFqtL4RMFbh963TRNyy
0UrQhgoVqKLoKJaJnWYER3GkLFWPNx/1IZA25CPJF7czaf9Qd0Cdk+g8+jeqsDdrBXoxSn7IHuKJ
uBYZ46pNZgORswAWdMVOogy9Q9oBbHC7+9q78gyY8NkAmg6YBTRhMJK6EvOliYBHdyjNnYkshRkf
clAomnqMuvubAfL0+wJvSX9wSyWRUhmCuBYELcw5VsnU1rMqw0wLKvibLTIDBTEgk76LTYyQBI+o
7NqzkLkSaN17o7GNEX1ayODAq3YS+XsRPsvhN4XnAaw9H2BdQh84TAjiPLb1Mgo15NGLBM26WfQO
rdYK/HdMFBguxHwSCJjm3gtbT86BMAhQ1/vbQi8Ne+KX0plz0KQw7Ns+EnwjWNAvBr6nUfN1UMgM
WklGHijx6qlrEqJyHSA9mCBg9CtrZGC4VpA2bZIogVrn/XZWgBiMbniSgfceWXleWLTiO5twrzS8
0QZNmDGhV9H1Qo/zFFBmnQESKqPx4Wx1mzI4F+DKKXuLmC3yZhhsbsuDXJ+L/FBOnCdydeG6BM8a
fXK0hex64SCmyXohLgR/0j2z7jZGDTBK4wjAcNIoHzJ3vGDF8TExgYuuXlCXGyAyuZbX6ouQTcj4
oEqki45VFQVqRFLhDEbJQwBetctoCNVRFsU9RgHuWlY3iUGYhi1kIVdhQ5e3QiROuyFKUbHNylNo
gfAhzUptP5bRbEeSznuIV3cXtQ6ELjquOJsOFeYom/tIFPwAmmtlyBpEm6I49BYaOrv3KHu7f2dW
VwxpGBOhhDbgSL1e8WKN8xTkOM02PwRJ6rR/VN3WOu1cAFdeSwnCb1H8Bxf1UiZzoik6inpFgsy8
ITp4Ziu3H8iU/eJNva3tpWziDQBGMDoW2LWNzTB0gmYJfqMH70VdbqpMTZxmQW29TWy1CzkdKGvy
wBYI3gnEnnjs6Ct48byWqST3eYqz6w076WIPSA6e1Mu2WL9M+fb+wa1ZgktZjMuSxrEYlFRPxmkh
cQ9EdJ45XXtALyUw97zGJETRVbPgv0ad7OqgIBBc2lt1fx1rnh8FsYdbApMCzMvrPdMbvZNyC66X
XuunydyG04sZ7KoaPVxSjQfEjR7vC1xdFrhj0MCDygZqDtcCwcKdtF2yCH6xWE4iWCARGPxMET2R
V25eM1yKrIOpA2kOBfy415Lqno6T5HDyKu111I+F8T0K/txfzOqLeymDuUo1OqT1BolbP8i8MXDb
18XcGmgaCXYFwLRi5dP6NHklOc662BbwyeyyYBkg05L/ZP0f8MtXwztnXWsO48W6WDOoKwISKTrU
W4ENErMDSAaJ4ovBFvni5jN8W5qeo4hrFwpYJKjYY/YKXUaMS27VYxcDCyE8G9koOouizWQpCl7b
3e10F1w3JDXB1IWEgayxeEJ5HMhhU1WWPzjoDLNRYSQxMdzKff9W2SmwxXkS1/T9UiD9+4VRqtug
CiSlsHy0OXi55A7Wr6EBUKZkcS7W6tJA+AmWBmTdRY1NAJlV1JlmrKNUCyTgVE838fKz3peGX4wx
HCI0Z54ioP3gkZklZOCDo56858sTR3PWvMDLr2BunVZG1iJEBmCX888+PAX77ntjfUP4YSflRIbc
FTeCDhw+fwISC5DJC1foj0tquPe/Y23bdUsVQcoMLixw+11ve0ZJZUd5CnxMKGE0AlhGyaleLDKk
HUdx1xJhyAv9JYp9dvRwMfPMXAK/nUPXVAk4HMx9oSfbpNbOozUgHfWUFiKZTOmkqU8Nr2Fo7eYA
tlSlu66jpZS5OW1StVpRIP4BHOcsRCSaONZg5UhxMaFRcIpQ8mYVa9CN0jCXIjy3VgL6D1CqoiEu
Tn9ENUI6kADfP7m1XC7IvgzA5YtovQDpMHN0ldSGvZJF5/yPul8c4ZztzH3upqfpqYxJ8BzuTAct
8bzOe6oRV+GLDr8HDh8lGLLg3jMaE85ZotSDEaGFGl0FDu06UMG604HD/VgZm3rkeCsceV+e4aVh
mJdi7ErIk+Li1Fg/Ijkjwny22le0TzlNsW8STtrj5hyxQvBRqFgfiPaQ87re2F7qwnIM1PA8tJlb
F5RI0wM7fW2p3wIebsTN/aOy0DeErihwtCosL25eV/8jK1Ke0Crj1WVPOkPwuD0jPEH0tbzYRnPK
+zBJzfDcBw/1qJAAAViXgwYpfbmvl6uCEG5BIdH3ZJisIGSoGkQM4XkaFCdJA9tUH5LF2pXyr/uC
bg0K3TtcAbTafxGF0gt/saQsEcOoGKPorOd+MyaulMwOkhyOmpf7SYkPWeZHCnpfdcGGjojlD+5a
13Tz8guYtYrI0ZX9lEZn9F9MQboThn2rxztTzZ20BXREljtS+Hl/2Wv7C5xdkMKj7YnOy1+v2lCq
NlOsPDqLCC674rs61rYe7Li1zXU5IA1GDzW6jNgOnqENyl6bquisZlsx/AT3PCnTl8jiPIRrlw3h
+V9iGCuW1OEQ6R3EDOHsVnFPtFQjY9rabS26EHh/827jSOgMwlaawAZL+w0PdVVXWo4oDOK62ZZg
w96TeCQBuvHNwdW+zcL3NJEcjtCbfCYVqoFhFZTHaIFkUxHFPNddNsNSl67qCdvxMTlGu6j1FU/n
ldaobWKtM2V7BRSzCLBillKwrrphiqQxOgtqZ0fHEBfhFMTfBNmLeIpo0RDkRhbVDfT/IrvHPkCh
oJnD3A3R+fD9h0Fa93yWyNkiHxsgimw2OcE8M3lyn3YhIU9PibP5xAQwKoqAa375dB9efjz4b58d
ZoKP/kz2vv3uuw+L7Ufux5/HV2v3eJjtrUF6sj9K9vv2+fFja+we7edH291zDmhVBy8Wwhj8rKwQ
HNGFhL4KrAtw/5KFlzChxujeZjHPZorRAAXsyZARghEq1nsdjl7Icwq+nKhbMXia4bcDls1gwsYW
JNlNGvZ4LTVMxJU/QYFGohTdd/NvQdwvamzL+eRhwgN5uXrcdgtoMcLZFtOXRn8q+soehZIMo+Kg
58u7fw2oMbz3aXSHLsy1XBfotxIaGK695BQ/OTnH1f0FfjLCZQxfWewd04UpixNpic5pcdDTjEQV
x1CtCQA0NlDOqYOHF/v68/sxVYextHCzMg2mvYapimaMQdzfpBWrK4loasV10um4N2Pd9TJVURc3
4dQ9kQeKb3D/59f04+r32XxMECOf19HfNxJ7iXJiFpJrdGcUDIDk+VkZL6bk6PGrkGd+l5JJdTDL
nFY7UfoTAUQ++CetoqiYXS5Zvt7Yoeu12pyxscOQq2ez0qSdEow/7i98zfCjBoFKBNYHfkyLkRIN
xRCjyIWnOo0IeIqIso0SO1EelRQU0Yi6Zvu+xNsWZbquC4nMVRxB/ZpJASQuv9GOTF5M5+XXGYQ0
KVBnvgNIliDMI93+7fjuTrb7Ydp78nOrTJxb95XgZ67d1Wcw1w60vB1mqIPorKRH0QTecSyTBYlM
Wm+qMx294Sd1TpzM6InRmwdJibypQ4frQTA/Oqm0tflXJb9H4cs4nWU0pyROr4FHO4ptWAlYII7z
vfKAXX0uc82SfBwxLCNAQeuDWYlOglbCXmyQY34rs5oEFm8adcX4XwmkN/LCLKV52Iq5iv1Bie8h
sgKnFQ9WEDlCyVHBFWcRgsDOiooTpW1kXgBlbOU46tP4PIvv9YCWzMJRpBlXyskV3Ta0d235fl8F
b2v2VAWh7xINeTEIyFgTVW+KpCmz+Kw03yUTll3qMOQRyZ4slLYQWDsB/eOWMO30+JsqCBhEeliA
5lOO/zEcEf0QQwJMKC0KofHoepNbEG20ZYi1T4YEOHNpBqRaXrUc67Z6lBdSGN3pCnEuujaMzyDd
Vb1E8/rotStAOPx8f1/XThJ49VgT5lhUsO5drybuEZN0/QxC+UXct34Z7oOhSEk7/CryiFi5tdiI
e+7LXLsXlzIZ7Qn0IBZyATKBnvmoaLqrumEPBHvNznROE/aaKHTYypIBUC7wQNBtvrgRej3HiBDL
5CwB2GneZJ2LTs1afQi6k8BNC62aSU1GHgNj2qjK6szChmGQrKDvIC0XXQHQ4UNCa4Pji1B5QSid
4qG264E0+qMQbWr0WDQFma34ZUqw5ePo18PnKCi/81/qEaOLzfRTNkkdv/UoNE5wfpJ2F+lbQzrG
3S6RfyTq+A+UDk2C2C943QgdGPsR60u/CEmdnOOl81AIQyObnh9zqbY7XgV/xQWRdKSuoHIKRqIN
5mCCDuO5gpUlZzn+QII54aXp1/RaR8mWdlfRNBnz+20dz5qV4igsOKbCsOyS5VRnxzoyCXoSx27E
JFXD2b4Vr5CSCYngAIXzprNdCYnR9kG5DMm50DEyhOHUJNkjMcq5Pas7dyGFeYtVRESoCY3YOT2x
SN6ZH8jUp+79K7q6fRdCGCOHTSvAy90nZ7H8M4FW2XKk4lU0t5GeErN8T8aX+/LWfEUDjYW0nQNt
/1/x2cU9lUZlhjuHrZNCJ0qPmQhiEhXAAgVvDHfNrl4KYhbWTVoL8g4Iko1nUWtdycD7f46NdlOo
zv01rYpCGQp+E02hsr2KGAaeYtBg4DZ1jSMPT1aPQq9gW81rInzeF3XbS4aMGwpr2DgJ/T5If1/b
OTG1jFJPESvJofaQz8XWbESCJNJjkIJUL1gcRSPaYpvCtzjm9XGvnB1kG4jR4BPA8DFPlZqpYybI
kD0oT1W1BcyMCpOue/eXuLKbV1IY26SHk2Ahkx+dewxPkwqdp3pyVCbg0y36U6ru7ku7raxgQ+ly
VNSyMZxmMeJmOVYzZNbjc5/IYGBKs9oRM2O2y6roXXBhZa42jos3SXVFmsoIDkYbJ6dIN4INRqsw
Jy+U5es8IvLsjJ6HO7xyO4F9BqsGG03jKyYAaHWwscMVhvtlhV4raSek1T86NSdTnmCwI3CktvsB
9pOf9zdlxb7JFAkAm4J7il6NayXThcSo1AmP6ThVL2maPxeGSBSF58WuxTcKolM6s4KWEIVNk2ty
G3aJAfgGUdcAPZBbNekXzF5roS+giUDuQjh8JSlyJJgxGSFwbN/KMsGtjDuEnhRoAPsKAgdRyet8
yM5NUpB0svX3BTy097fytooMZOBLIVTdLwxeuhiG0Fl9dh5nUs8kJ6pACsCukgRggO2bzAXYX7k/
EIjhXsxaAn+VzaYkYhEHAeZhzk1jpi6UBfyHmPRHy1wRfTektn4I1Zw3ts8KRXoS3YeYqAWMBFxM
th4f6WKQx5aQnkd5QB+vZ4S+hia0Wje8ROFkTW5y6FQYxld02FuKRMV2LSlCpC+dAmGh+F71/8XZ
de1IrivJLxIgb14lle8qVbtxL8K4lvekDL9+g30XuyWWUMJcDM4cYBroFMkkmcyMiBy3ALeCaw6V
EKf07MCx/F75TtGMqIA2qqV4mbkiICD6DbdvQKrG1DnGFMmb+ZKOZuiMZRvmgRbmLrLZI2AimfHf
GEFxE+toQURGBG8UKH44GRDjQWtAYdb4OrZQukjWBL0Wh3JjRbglI1YgNsiSIphQv4HYllcxyydT
txLK3D3q+JThP0DP+eMDyydMmT506UCUPEC7rm1nj5Ibl+8gOOnokna0lJ1slAelsLe6RNzYQV91
PDWjta0ovhE+P8JA/znAh2xbE9HgitJKPbUxpUAw2j4JIauuecQD+h3teF7//PkoggHIjscHwNLO
4F0uEJ4qYD2LFWSUVaPCzuEsFYlfZHZEohP+GW6VfFPJa4ifxa3h8AABYHqgBMTSuJWhXbHW8iGy
oKO13yO8QtKPF8lzJCW6bDwkzug2eJOwJt/X8UcBYY//YsTox4cdqqE4KOYMDLQObdowLgIZd4hn
D7hWI4RH0AoZ0CSt7kI3r8Zk/9joXWUZi6tZqFfwrD6YxWJRssKbJhxsWDVafmv8qNheHavvueo5
AzStzGMOxUvlRXN+yUbhuxNJQVrEpWasZEzu1puX0QF+Qp0LIQWqDHNPl2kV5jGwqs+2JskbOZQ9
k0ajxyYWIUFl9KAJFd3u8eD5Lr1Nl9mwCbVt1KOAxgZYQXgpSEYsjZnmJM8VmWK/i1UFuHqVrVyX
987FzUAcFfclut3fwXj0FuIfQBEkzwb9Roa/pG48bVK2JUm2Zg2ZguFrQ05x0l+c9JI0F5KTlTPx
LhP8OdCbLxBPXiDa0IXBTp7N/AjCqy9Npz57MvT6O6phtFdclBfzsfA69fcIUgN4vUdaM781XQLN
53APeo229k18cmeT/5l2wE2L+AzK8CKtpmZSbxUUCz4USnVIqnTYZbmiHLUQBO0majWXpZ0CUKtC
3Gww0ECirohPukTdym1aXPXY5lxdQoYjIwpznSyEKEzdofqLy9uvC/IlNvRfEoVQYOMk6SaOkQx7
7EBiZA9oBMdkoL6IQwPKjoLTxmXZ5JOZkzNVQropoeru97iBdumYRn4Bxa61qHvRIABhOIZBRYLf
zHeJweJYkkhDzjHKV2XxYpMXFdFR37707eha/Y92UA5SiSYRX7vDEJ+o8QvHF4utlYvpMy90u3p8
5NABgRgHVOpBmhQ+JIIQqT1UHTlDyOkQKUcyfNVKr/VpE3tRlGz0pnON8OT0lttIxGP9NYo34TWn
vyIoRdbRudTNfdV+B/cwxj9E4PH0XTB9MSVlN0wrd8kdYf7zaw0kHBBjQbnlM9i8CSbHBDk7ko/k
jJTOcaxch+qHXLXcKaeeTd4iqBgp3V8TpBOkh49ayTYdMXxd9QvzMNTHom09o7jEHVpDsAvoHa/G
BEXscQ2seycpxr8TXIVPgBYCe0eo2MhtS2TVyuk5t4oaYm2DUT+XStfJnspiCgxVJCe6n0Mly3Fp
ZMUndcoT9KcbberKCSrdNiiz6CsBYevkrakBo3ZNqtvHtAnHckOLVrmkGQXHswnTEqgoyS5+szQC
fB2aR+nvpjGGyFXstj6PeFD8iDNIYLqG2qboA14Sm21LLdOAEGBFv7JEYozxOXLku3Dbg5MDDuXc
sXU9sVDnRNax03W3DhPf6D9K5QeJJ4iJPNlrTAm+MUX31aGlooOjCV7u55F94xAKm6gZWTAHuFYI
wbPQ37pY68enw92YHB5QAFXEtXtxUPDr58aIqYyMyHElnaMkPBcQTzTk9mgZ7JRJZz0jeDuFytfH
Ju/OB5hERVFB9AlZCDxG5yZjFmktKrrS2UyPqPUeBnIe8URM9PfHdsSbE3e1hgXhI7OAdDCEl65C
o77P4Dnoo+7+q3IgvywBaUBRG7A6/oKfj4GOTmOZE15CEoPUtt3u2+ZoFPamr6eV4EeM4kVLwnYr
6qFsu9yMLsxmEMKDmLM0kD8SsVfqXHfeJoxIOCzzrukjVIpgR6dPCDT9uoxORlSACpz+ztu18oGY
/cCweBAJzW0d0R3UquYTONV6ZkU1JrB+QjBzHtEwqNgZ73gb9Mr2sR/cu/jcFP/5jYv3WqXRmMJU
nIfH4UVrNiE9Z8UPRHiIHlace80YH/eNMUmpLB1lS0xjmRxthiidRZABNkCqBhasY27TrTyZFxbu
dibFDKUZUVayHhb14hXtX7zeDn0G+QOQb+Po4/FU3m/d2VSKr6zepJKe1U50kQHMSAZP759KvDQm
c+WkXXD62ZgEZxyTzur1HHZY9R3oAC+r1K1Sr/jFXfpG8EHxIEIsPUJTAVYG6Wti2l/7sPhShupJ
fcufG/QzjZIXtQQHzmDo3GGuKJ7cn07zqRQOXlbVjtYqIbzSeneGv1Pxj2+Vz8Fx4C+ofYhcP/Wj
bhzRrMJwKJgUXXJI93mjYiSv1FQHL1Laets3ENhr6LiWRV5aN95EQkEWAMgXMenXFxKbhoTElyGX
BzcFsv1YWFOJK1leM7V0gCB9woM7ZFBQ7ZpvNNNsEzwKuvhC9CaVNtCmQDRbdQVwv3hMXfOuiFqP
oN3auGtYQzehHPXSSoS5sB34a8kCrAm5D1Dv599Q5DhaoinJLtEwJN+0xAFen4bDRhmJ5E11260U
Qu+SqlhUDdBSwPfA+kHtQRh0ZeUOGx2SXca+9FQ13FIIe5nt6EXtsMlYtkvD0KNmclEhuvZ46y/b
BqgOLA9ECkAdzQfbdJNuMEPJLqau519Sp5J3k9aUJ3xn5o1QxodWhCJtGgdirQrkGpumilbuwoXD
FWE8spG8FghouzB8YtWpKo1adqmcvim2I2PGa9e3wAHZTlw129jU5dzTyqZM/DDJ4jUGz5J9XJOm
zCVYwKwU1ptYYSmZJUsv8qTpuyFt8p1Bu/5dViOQUPA+P8mxRHaWWahrNJsFVwP5BTVdHnFDUEsI
OBqG/kYZpcWFdEoUVFBw2zmkDf2ysrd92+i7x6u9ZA6vXmwuaBvIyMXOF3tKqdpZbVNeIlZCjQzP
2aqgXoOjGPwiZc21Fs5CcChNlA1hE3RKPu83Z1XZy3Y7xKy6qMT2rYi6Q24ewiTZZ+q5iJgHWaFB
sl2qmF6hSIGOWnNXaCdqrV0JCwuM1iZgFxm8wxnKBvMPybqYxLrZ1JcGGabagqhAjPaFmX2s25FC
jZS+qFKyeTzVd2U/bOpPFQuov6DqbIhZxJRnBjqVNpe2svd99FNqnpviqxUGDvppAzFgpGSfTK+R
mq3M+8JpDTy8hXw37xEMFdT5aO2pAu1cKZuLopcfxIo2qTGAWZrmKxftkh0gKXjFAlpJANzM7QxZ
mPWh7dSXLMMJqeeF6ZpfwtwwV+zw3zN7MGEibRxOUJ0DJAHU3LmdFAXnsdGq5jJBWrhowSRHXs4Y
kq2ev2lr0toLPmsjwwGusw5SBrx3bixKaCiBT41UWFRUz4pUlrsICpj+Y+dYGhLSfxDu5pUsvDTm
Viqg3EPLSdpLrXmaoe7tCb2U0+jcd++DvIYQvMvkcwoNNLSA4ef68zjo5tbgqJIzOGl5cewDRXcr
0OKPE8UbkATGrtiY9Y+QPZVJ6xbWj9RZc8f7seI1CBEElJj4VjCEiEiWh2oytbS+5D041NEPGS1r
tOmAy8B3kjWZ4fvlmxsTbjOaVdKU1Vl9KQk6qrSA+K8JD91VnzGbXAsVNyZEeLGCggmpTUhh9XZ2
mTxnWx2VE3SW/hr7zuNdPIE8710lPjZr1Tq+RvNNwK2iHqGDQYe3r3ByZ7Y5aK0Kq4qcb0ZISGUg
faVd+FRY9fNj57zf13NT2txdKNpAAUNlZBDP69LEt62XLF9DM63ZEJxCalOphaRoDjJkCU59Xyf5
2UgK20f3ZvLl8XgWHHA2dcKCoZQzFJBfzy5F1LisOjQ5HNA+yVrlMXtF0nHNlrDVkG43ysTCMsnP
lbk1xi/kV1TZXl6sESoXXjnzVeJfcnO5GoBW1GkBS2A2Vswboefi5MgvTlr8GsetX0uvRfo0oIgd
AaI2KGtB0+JIcasCYgqwpaYJK+iQkMYoPsAhB+j7R+3XtBu28hS7eYRHf/X+eA3vnwVIZ+E2g98h
vQCS6Hy0xJqYOcoZmgw057Q803qno5+BsZeyc9g96/Kfx+YWZ/fWnvDet3K1mgoD9iBz6sqb0g9e
ftcuQ2vecuW2XogTZkPTheBEZV3utBlIZARNJatTEX+MZAeBCw8i1+BGg9JJXAfp4XrsV0wvLSGS
hMDF8QUEu20+qVk72RqaDOWXdpT8xI30i20j51n+zta4/4uH5q0pYV/EWWPpbQVTI/vKwAhQQsi1
9NuwOiVw32zaaZYfsQGKxjWUedAvMNya3eh28hq441O8SjxIb79E2DdxqDNqmBVOnkNzGTbo0Kq4
vN80fSkDQLS+R+fhSjbQFZfRmqJ2vXL0gOJ/7F6L3nwz8YI323rWRBpYyhc9+ob7g32Dwhvkpuhb
8VsuVxISa7YETw5zRGeDXecXK9qVcQ0yCeAs2wad1f5AY9bo19RM7qq6/H7UOC0ISA9ww0T1MC6t
EioWepMwacu2HfgH0q8CWMGC7RX2ItE/2rFn58T8UtDCZ+1moltzLQ258KrFiYS3JMBQBk9KC+nV
Tm6TKTUxwwW6XWu78VR8Awm1QL3iDxvdaC2nv2wPx5PCO/6izircma0kZYVF8uKS162muHjsj5Fb
pgrkL6O0V3iiyWoIqmS0+ihQ9ejcXJaB4m1aq/kvrjswTxA28if1HaGyS8eRyA0c3NC7rVzsVezp
KT8VVTDm44ojL13jt7aEzdTIKUoZiGMuKBZF3XsuXSVnhZctmLB5xzo+pYge8aCBjOn8kEK6Xidq
ZRVBKB/R5NgrHfTdXesxJZyEkInnqB3IzSLvBGW2z+W9uUwjnUI62ZLKAArTx1hXPdo9O2PqUQj/
jP328e4XneXOmjAkQ4dqVTRFVcDsHrKCgytD4mX039Nzkk+uZFxUbQ3gIb4B/mOTi23wrWnYooJI
Zxld74xtFaDDYuTG6By2SdXymfb1z1afgLBVleSU9gndNrSYfDQCT49IkBEk2JzKr8NU+hmXUrji
P0vzjoSLDJlYvOwQLswXN+q1iUz9VAVwZGOrJVZ8YAR1W7RU+hEPebNh+pSvOJR4t39OBcjcgLY7
UJWCQPvcaGujAfjQmVVQDhbxjE5XD5GOplTNUETbru2iPRT4Oy+XJMk3syI8maX0vVKs5jAgU/Kx
4gz85ru5j/7zNWDp4NwA0h6aB/OvQWeFwepqtQqMV2uvndLaJ5ysOn5o3pi5yaEiLtkq/xp1/K9Z
5GaQKoD4+Gfb4BuPr2WgT6xGx6HAqn2jmG703E4I+PvOdaBImJlH6mwhSbwqer645DZOZRvlNSAY
xLgR2H/bZFEdyJS8d2C3bEKoaHqqwUClQYsT1xxY+evxJN+dIdjevL+nCq0ZhytgzefYkIDWkxir
gqRN9K2kpZIX1xR0fd1KN49N8c8XlxP8DGQSkYIB6FuI5kw2dWFmK3VghT809d103h//fv6pj36/
cHYoUmyYZarXwMj74ZeUeIrlto1X5js4ymNTQuTAXYSX8IDPwv15z2HPWcvSMLfqIPuoD/U1A7vA
byiilHiNTrxmia/fjTMOSmvEuaPVgeEEln2oep8g99y9TK+S4Stk5fxd8MDZuIQdl6jMHHI+Lj1/
NZKNYjzHP6PijRkr4fXCUqEKjuwnsi6f/5+Pqkmh7WPYE5YKvb76wh0+mmLwZIhN5kgrj2uU3gXP
m5njw76ZRNuRJrmTYY7ZP7X0jSrXf3cHDaVi/uxEIUikgTiSbZdJg0XK1RatBN/M6ZiFH2FzAAXJ
BH+hj1Z1UnnUJDg7KgJcQA4oJ1CFhKgqq6KeRBmcvYP6VH1OGq+GGMxT4pp/wrdyciEwmqLbxBq/
b2kmUU0CqfYTUS+aVc1JkjsLDmKXp1iKILVP/MdzuWaB//xmrbpYrrPShoWeMGlTZFHlZlNCV6ws
OSCueq6shXQweN5zK4iWQIvQYMVAV8C3XD9oCDuzfTrtKF3ZU3zPiCtlgqqIlyTiJySe56aQXJ6c
LKmaIDK3sX1W8me1QIXBWrm7l+bt1ozgEH2othW6wMEMHIGUx1jd//vCIMn2CWBALUjMnY8E3SqU
Qm8C2+48pTiX0yp8jU+FMFXYQYC+Is3sGODfz6cqLwHKRzajDSx6tFD90F0AvfwsOgLjt5WTq6Lu
+8kbN+Pe6d6TWN+oLmQGB6+lvqFs0eKl+MciFD/oZ18knhwl2kp1o9UGo0T2MprXwhfdMv7oUex9
PL0LFzGi+E+EvAmuipg0iqQKgZ5idQFEYu33fHiq14RJFg73mQXhKkkLSoa0hgVtgNxE/2HapwTx
rJLiOTY8/xejASHORGkLMqliUmqUzbypi5oEVENhWE2MGO+GNN/nqR6t3CVLEwenhCAkIGoAKAlh
xWD2iBzjjgRsUMCyOSupsmHT7vF4FjYx+lvxSJzXQe+IarA72cwiJChCOGRBdnGWoUvfdGyGeiVP
uhSEg4MLaBoa3yBXIJ5N6dDhiFUpCVCaOyndbrLg/PqrZr2iZYNX6Ok2Q1kwlPR9J5k7QHz++cAC
RA2YP+igqhizWHjVkdwrS6NBQ3kgHO3wb66+QXRr1NZw3vcLByEeriSvQ3oVLi/4I6VxkqIk1gWK
lHtpWblVq+4k9KJ4vHT3R/1nDRmcBaQ9UFcSDkbSRoZa9owEpZ4i2ftWpQeTeZPmuNUEjfg1MPCC
OWR+UZLTof1jWSJfYCToDzNkGkFAbX6RkKdMN33nyfSt9Vgj1yuDu9/Tyq01EQrVjOHI4lQhQfMR
PXf6xYq37z3QAY+ncOFZPjcjXJcKQc/kSJkgUlL+ntLen6xT23xXrHMf+kmCUCPU0Ynsz2Or93sO
Rp3PS5qX6XTh7AWOeXSkQieBvtN864U+pe+PDdzH1nMDfClvQg2Axx2apTCgolGw6Smu6Wu7yk9W
9tOCn8/GITyqQcJs0eoZZpIIHV76U1c2XlivHFALjgAkAQ4mXnBGKUAYi5IXdT1VIQny+qAmHZDf
oduhffzQPIerZbCFlQEVD69jnPCoOohyyaSvQSNLBhpMafmH0cRLow49rBXfGNYagYk0DdzAXKkd
uS5U+IDLsIV4kEyyOeiRSoP4AOjkof8tH9u3aEeO2RP5CL/1K/O45Ooze8KpJBehNKayQgOyJQdE
Hm/6od5oG+MA7v1j91vwi5klPss37qcMcloTTYYl/d2Jml/MyX6M651a+Pk2D6qgPsKlJHD0ob+Z
WFBHRj+vEMbQYEjPYRoYWvTaGhtJOprthznUtRc5ueco+5QVnqNVL+UahkmscHwuIfRPEGzj/uQ9
3ucDZTKEM2pa0cCxc9eCwj7aU8XRSa22oXFlzGc5OAqA/ce+kV8JcnC185SvRAkLxzLXYPm/bxAO
E1WtwomNPcUtsBkG8gTZziebdPuubVzZYt+ZvJZMW1pehes5I2SA84rJ/gp4osEssUnUaR9Pf0vo
/NfVytGy6K23RtT51PYl2v3Z2UiDfDj1Vu61ijcazLXlF8gY5dEBaN/k9bHbLm1+vDq5TwErdRek
o7tuYRYKTBJImWlNoJfbsfwaGmv9PhftgM5uf2YjFZEMwEwnLnJTo0GSOj+HCX3bY1RL0q+TvoaM
WDxjgHH7P1PCGUMZlJzjTqdBvUVYADoThHjbbVVt6eDGuQ/4R0v88Xu3fzyTC5EetiZALuhmo2Nv
iAl8aG4oTK4xRCetnpLsTGiJbheQi0tKf8itzcA0l+AblD7c1sP4LpfdCt/r/tU4/wLBf6RubE10
XIH/9O01Vcm7Ea+t4+I+uBmkEH/R1HaGUscBHqnVplOgztM/6Wsk5s/X590pd2NFWMKCQjIng5xD
oO2TH13j1n9+xRDM3qgmmqq5BZrznPp9jvQxsqjf1Mjt9vXf6hcqmCZxixQMWpeNXvoXxKfHa7w2
wcJ1AtWvpIooXGtS0YgCQm/D2vwuey9EjzlqCkBkXTChMAYVDQ0mUtXVQTNyx9hvD7/VcQuNsfRn
dlBfHo9pcWfeGOQ/v7m4Eo0qZWLyMR3zAwjr3qCtnNYiNfI/V8aNCeG4pkMijynCM1wZ+huADZBy
praXxF5NjqhbHIzcPJaJp0/NoUSDwMw2niIzco2xO8i14dYQYdGlyTU0HBv/KId8921CqJU3iOcG
G8NvNjVpkJ54Np+V7L1LLPTVuU6teng83YvHBCq2SLkAWwUgsuDbcZfRTpOiPqDkRZ4KlzgJFEXR
v7NQz2x8KZG4Z8gBFnK3aw15P8a15j/+hKUVR/zgcAgw9MNFHpiZ1/JkqmwIJMAlNYh3qIOrtb/1
NUDc0lmBBrqcRSlrqGgKIy07IKAzRxkQpSDNgtT6LwYe5eOxLEUCoMuDJwl0Nofsz71XyzIskZWO
AUDym1R+stTNSK4j+Dg1Oh6vTNzCEwO8aRzu/EmIkppwvhYOlULVLMZAynpviNOdETc+TvSGlKce
fUObLNvJa8TKpbfArVHhxG2lcbLyIhvxWvsbZ1vLconxzawOeLg9nsrPipRw6iKoBJwWAHFwxEXP
HPrGqSDgMwZWFXktumiWIIZRmbzVKvHD7Jdefi8JtMC6IOmqbarbO1P5Xic/K6n/YSb2jk2SC4W8
zajkXq2FkC7/49BX0hReJhdrkf2CE3OBC1S6wDkFPURwLsWI4wzV8jEo0Duh8s1vaG/92cIu94r8
F9kUvxNnG/8t7c0Y/o4bd61tMv/94mTd2hfOaTuyAU5MMFlSqh4aS3q1x2otouDOe2dD5w8lnBNI
bAtHs9UmSm40zRgwXAJhSH/YGnpOkjMgDjGz3U7LvYp+RE6xsZixNsHcmUXj4AbygjWIiMjGzXdW
Tg2qQzd0CnKKpnQAV+zlkROOJS18k5L+l6xNlyEi0i5p1GYTy+gaSdGMe2TKmtjhwh6HXANeGxD9
QasYEarcS3j1kCLFl+hQeqz+yg69Qm4B0rqeQ3/IzgohbemFwwVcgIvmqO+713dnh4Y+kH5C6bH2
lGjc6/Wmt4ZP6CGLN0USHbXKn+qfhf61bZyg/Umj8JinzQoFSkQY8bsJH2L/r7I2MhjzJbDLzs6j
jk0BKYN0vDAKpVXtZPU729pMZNtbzq4ephPI2IcBzTLlZCubF6L8LY3o39OY+BSOG0ENHfIysnD0
9cDfR1SepgANxqBqnP6tfaeHekCgXNR+Y52Z/c2KVhBdS1clCtYWqgdcnQ86SPPxh5yNlRHIhdRW
vRn10Y3pHoAumTKUCiq/sJFgVN0sYm6NRj4Amq8l5BZWgCtschAF5+DjnTT/AjOpxhaqHixo0q+Q
wn/qfmKKTk3qQENxgPJ2WHuS7EHSF8TPVtqjEZ2rRH/6svwTZ78eH8/3Bw4ohcgfo/Ec1gEypPNP
sbWJMqrKLKCjUrhmww6OnqxVBO9P1bkRweOUrDRisKdZkJNjVe+KGhWuzRD6j4eyZAUcBwsZYxQ7
UXycDyXuB0NrSSsHRhp5laW6aJD+kfdvj60sTZjNqQA6VOFwXwuRnZ0O1mBIjRyY03QaVCtxtcJe
qYwsPNkB+cetifcmBE4ccV9ILTrYFYTIQUyP4bg3lWMinUl6ycMOlVzN15zIi/V2ZTsuDQ3Nh1Gh
BkAdoDFhAlXwyBIw62VUIdvJHdiUbSxFW6vgLS0T5+rBwZEZuKOrxZll5Chay0GF399m4Q6cg1ew
+37W8RqJaHFAN6aEATGnzGWSG3Kg6GzTT+cM0Nh/94bbwfAvuHnmgAkVaU2jw4I8XfupgUCFlq/E
9vcBLxca43AfVK7gc0LxCt0gVas1CpljYrIw3srNuVLYykBEHDVuBW4FhRaI6IOFLkYFSdUXtLaw
e8oenaQcvImoqx1VvzySc/mjXjF3vzLomMZZuGBsAlwk4nysuOsVDEoNIn3ySbvLe9t/vDL3s8Zb
wCHi5NRIZKCFEN7pJKlL0YMjkBmwenm7gcS2XwCf9djMvTcjksKDC5wnLpAmFiDGFinaijA9mKDe
kckHwiDaYhyTbA0Os2AIZwGXfEWiG88S4Qy1pELth0zRg5I029RMrnVof2hdEuik+Pp4TAuLg0cc
UMiQX9RxPwkOh/dbWbAyswLclG4s/6hxkD62sOBtALBB2wjlQ9R+odw13zdk0o2SkcoOLOD0iifS
TM9diMbu1uC4XQpyVWhKP41kAOJiPDsFChWPP+B+NoFOwQmkoH6DA0KswCUdhFHQZsEJ4u5Mqew1
7dlskcJLVrjJK3bE2ts49VEX97ETSJCxDyFm12vMVZ1Dn6/c4/fRLB8QJD0wmyini7WdcZLVduoz
dM9zzpN6RKLADRXjhZY/lUg5JL328ngCPxGO80Ae7sEf4BpomqBWCStYmUaZtZIuBUZMdDdT91B8
kqvh2tqQnCp6D+0kvdbx9fDssGeWx24n/akHDYEMeoACQpv8e1g3/yC+FDdHsWMT6O/IthSoz5CG
kb4ZxD2EwI+/lcf+3J6l7eMJWJhwoLnQDRpVeANgJyEO0KIQxB5bja9WJflM+plRbd9KzSYJJzcZ
AMErpH/1WRiCODxCAoSOUOIWaoQ2FH7Q7q8xL4y9OlNBIMWAlHNvSR8DtH8ej+7Obz9t8TMNTyM4
lDqfTNLStojtwbxQ25iOSde92x1UjFoA7repoa1xYfnhNXMmmAOkFXV+nNk2XgNzc22toYbbGtZF
7v2a2pfa3PVt/6qb4Rd0I1mzdpdwwaHGSbFcjRlwVlGgIKprHXzx3kZn1W+m9bVvIOnSusRqQDlA
6kq3PZ2uTej9CGETsRV2KOprWMf5CCEVUyEdk9mXtmemXzXkithy1/aQMCryyfCg6L1akV+0iU0B
2AQ0jKGVN7c5ZKVS04zYl6YtoXPZkH1lmd2uimRlD2zHSaMhWhxl4OZnVfm9QsrBSxyjdo2Yma+V
0/xo7O4KNFIYhCbL/QaS75vHbsbXdb7uKPXhLuPrjtZqIl7MGiQnQZcY+5JCBTMqmOZFtPhaF8Xr
Yzv3+W90H4OEKdeHwHGFBrHzqSgkpdejPEI3yTPG+wUa8GDw97VvkPeEt4B+1T7AqR1wma5lPO4u
U1gGmQY94xFYy5BnmFvuWkePe4oWnVKaD1ulhVQRC3N7JUa8Jyjw9mqcUQuHBpJAZOwYTlSHba47
F0tuzR9TRHHXKGAYfrPAkPvVkAKH9DREzjcG2j1EhyEEEbkSzpp6O05Davs0ia18D7mBfle09iD/
a8DHvw+aRjokeoHuFvM+doT2HZQN4aVlEXuKLEA2Y3UadivrvDDbJm5A8BIAGkahQ4j6zEqnWaeG
4QVArPrEEPw7rtJmwNXwTgMmM6tdZk32Rs/QzV3RAJUuzTryyFDQjWSnaJ1K1XzjFNmwMv67MwfA
TpDIwd8GRA9gJuGE65qxzuQ0g0ypqubPehIruyjMyTN6J3RenKhK7iZg9TV2M21KiWQrE3O30T7N
o58OxPu5Dg2ft5vL0Y5pItOaK5RaheNDWiKBMEqYIKnZ/DMc0sRpYyNyBDsff1uCqalJ0HrStOOr
w7rhT14gwO8Tpd1PXS6DPhPTnytrzvfu7BCBQT65nDbAn63CTZyZpUHzJEquZvdbH98GJffHutsm
77XKABhotqHkSWjV/djs3Q0J3VEcWVxQgbffFd8XUdy3SZPZybXU9HavNmq0bRnRN5nZ1W4ylWty
IHfxhmBPuJGHCo6KZztGaZ2a4aWRXjKQQAzkaL1CXatIirKLvMc51g/CGwiQ8RYQr8iOkDjvkIm+
Dp627ffOJvd7X/E13/ZzX3GlTeZJ3nZAUfS7+ru4UsUzSm9Yg0XfXWCIPni8g3AWsrq2IYxZUtKO
UL3JroWBpFyZlV7aOx7TjV9NmP/K4miNlb2wqAjpIE2AxPCn9863iUp1XWponl+15ElhoSuz6/sE
Iu1j17lP72Bct2aEw0BpOr1Hn5j8GsfRDqwwC6JySpTsqmxTRaGXo/pNNXtfK2sCfXenkGBYiEKg
ZZ6PViZlV7nMfAO9SfKgGS+yckUNyi1zkOHrzeOxLi3h7VD5z28OngGtaHRszvzaThfJaX2yRxZZ
qrctiLSPLS2sHUo2EGFCSt/C41WYVEuq0x5dsyAv2+Yu65NdkXzRiuHC1G5l6y+sHy4ZLrik4ymO
ZgHCoOw2dQhTs+o6VZZXEMPDPCaj58TbtEj3iuKVYBMZaCmwMsT71DXYMIC5QQ8YiQDETcL6DS20
aQaLVVcLXRCa0ZuY2yFt72zVeEOKg4LWW628U5J8b0prPT/u53duWxi0kxOovssKbI+vsQWhgnJf
0Mibvj5exsXJxQOW7xDwfNGSc+4xZVoRO82a6iop187QvKqLdmP4lDonZIyRE4WQ9dWQfj+2+vkQ
n18ifHT/b5XvnBs/naZktMqqqq49DrjsvX01fmXPadCfdN92E6/aAVX9VG3lU+GHwfRUX9JNvmNX
+UV9mXZkaxzWtur9eT/7oM9puvmggqcOCO2qq0IkX8ocbFfdK9qDIpcuQT/IcKDfH8/B/eEwtyjE
Tm0M6WOZYeL77hltQHyFnctu2yR+MlwiwETpmpzWXVCCKA1YFGwinrBHH8X5nJOiLntELNW1lU2v
VyQ/stV9Ua7Uu5as4PLAH9xpyARqcytO19hOU7H6qoUuoizpxyp+5z6bxcNN+Cvk/pHOAoRxbiKM
RrQLceLmKoUdxFFa0vuDIzNX0zptQxr8Wzdmsl+NeeXl2lh8Bd8Hkt3gfh8eL+HCHkVFU+MITogA
4lE1/5ASnYYQtRj1NdEhNddH27I5QpMQYqX9iqWFWUV2APVjCPGiTm4La1fVKNQiLVdfKzq5pTxe
W+DQ0CbqX7Fn/CZGLQfpVbxL7oRLHL3IDNYXzdUu837bxLLsGZQ128fTtuD5IJyiKIuu8MgJikyU
LmZNBsWD5oqy9dYIh2OR2M/pSUqm74pk/5xytmui749tLp3lM6P8o242eDxEE63srrlOUnXI0i9N
i6xYeyyk3i25IrhBAQQ/jPX/kPZly23rSrRfxCrOwytAUrMt2bJj+4WVxDHneebX30Wfe3ckiEeo
fW7tPKR2qtQE0OhudK9eTTNBePGr8Hhf/tIBoskWKouaAjDuzLXoZGMI0k4qMS9Oc1vMkuy61mkE
HrXDopg5x4LUOIpWrMfyJuS0rEItj4GAgm4JnB1Iet2x0D/vL2fBXAK5/FcO453MINR64B3Ko2Zs
5LJCM/xZyirS7vPkEX35nEa6+dcYb4FLhkBjbk5Fvxtzdj4oB+NAq6rjUGfNSc0j/bXNY4uialjv
u1wunEiKuKwcswFmpQK1gduGTsG53f1aY4wEqdZSTaujFgVrscHlBv+19Bu51Vh50jRwYjyC9XYl
JCHn8bqwuSDAn1kuMeYBCGlGsAR2JAz5bOrjpOWyk5nnrgSv95DFJw0NrWFjGtQSUAm9f6Szsbpe
7lwckCF0JgBERHe93BgghDQR6vo4GhUQE1ISvNa6Hp3uS1mIN5A1wbsYrVQAewETcC0mK1NRCFMV
i0vHeF0Ho77VMHXAVgTNpyGagp/ysh8w2KxF/zaoft0Y79815yNujxYfgfwQKGm1uZbEKJQemw1G
KFj1UalKmWAYGnJulfVTGlR/M41ANhqdZ6FkrqU0T9rcSfzKQjY2+tcNnHMKCdlJvKZRmwFk63oz
MBZAnJMm9bFFJgL0sVqznqK0XN1f7tLJXkphIo3OrFC0CpFcxAyZ3sGbpbWzsW6c+1JuL+m8Fjhe
zJtGsYntkfPQzV2HKfZUasud0ngRqPL135EcrHzMMaOB3nIgPre2DgJBiAGRQGzjvlxvnlyGqSJY
EKiJo7WSAum3LHk5WtYr3oid+ZeYq4HR03gDyAAuzWiEa0nIcBpoYayaY119dsOr0v4s05fK49jU
hQ28kiJfS8mQ+R2UMm+OSN1FdoiBRyQoDY8oPciAMlBeUz8zeFUOVjcQjqAojNIS/DGmu7AZvLFC
x5/VatURuJmeFkUJXsUkUDkW7SZkY8Uwa5ObIpuG0gSg3awJkudOltpJ/8frwKVRn4zgzzjWG3S6
5P9SR1i5jNud+mJIkCqujpb+2kerZnwZotf7ej/bikvl+BYx7yEiUZQaWIPmq6gMJ7VfH434Q65T
UgFO2mWKg3YW8Pehu0bVyAQw+32p34OWWLGwHACrzBwHSHlfa0s5pVVReCPMtepiMOSL/K6fw0O3
9fbZl0H9LUYZU5UYtN4k/jbiDdBmdRVcrTNXBCrkSBbNZZ1r6WOmt57noawSJkT7nfXBJjJ1u5Q0
G2TgnNDpBnnOCmOsdZEEcpD6UnO0EqRAXRFMASWpsxFtZyBob8gkxON2GGCd1mo2GLojyFkd0Kat
coFohuaFK0+yurl7vZCTtVfWBkgO4xDdcXqYhJFddLUIrl0MC8FzotDrhJZTN33dPzHWiGAVAIDi
pIBqRFWEHYGDd6WvN8nUHZWxi1YCyj+rGGTNaEKK1t5YZTwft3BE88WeKdBlkN6qzJULi7xX0iTp
j+gMlA9h2ggv9ZgamGrdY8CM0NUwL8WExKJYd1SJC8EuCkXAIKuoo3jeyZjUJq+jokCuURDkTQRh
CL1SbscNm0/GvuARYGDmzAy2gSm/ViVfGNUhRK3iGLWeRXQ532lWVb8nk1TtEyVSyIA0oVPqebhB
0460xdDBiYPEur3CM/prLq8D/gUvy9h3sHoqRZ7L/THs1X6LtM+DACqFN7UqGicUhvyxDb0Xw1ce
pKLrOBf5uxR5fZHnEhIs/zz4FKgCRngijwnq6MpwjHy5fKwSb3BBlgYWNJBRU8QoohsraAlsJaHb
W1OaP+hpF6wB8y6c1C/6n1ECrty4UWQaYeQzptdrPRIYIuaoD7WBgVBZ6iRBCTtbVMZWxtUBa1MX
P/Re2dPGUj3MvM9T2uWeRnVxfNLDyXI7sfPXQqc/V3nZUTR8OgLiQ9KnjUK0LMs5z84F94BqrAlz
At+KGJ8F4GV+XCWBGA4YNf+rzWXbH4WMBq9mHq/NWD4OHtBYsotA8BlfeP9aLlyTK9GMh0CROFCB
ee+Pmaw9aLH3XOnS2wCm0LrbxgJS7vfF3cS/s7qj9D73vaMiDhL1a3WvizEtBzEZjlIUUTNX7SiV
cNYxTWSF5JgApTT5RsBMI9lXXY7sW2d/LZtRNTXrWqMysuHYGaNE6hKNOZNsd8mqFX6mnkFly7PH
DPwdah2vQFltiCYFZFpJeNDHpU3/ft2IM6IRYNjrTbAicerKocJ5Ry1BF6qIOKBDT99YfwFxwQk+
llYNF4WPnWkGMb7uWpgxWrVSdxMuWCSg9uhp0lqrrOrf65GOPiDkaGYCdfTKXEsxlSC1zMgcjnqq
nbrA1ScVDYKfmGZHmhfOOS5sH4pwKkCdsFewnfO/X+QycsNvUETSx2PYlOsw0EhlvpbjRkVjztgL
RLKmrVZbj5mBWifqzljraAUkN9a18TsD8DurktX9T2JjcdhuPFSRdEARC4k5do/HofK0ogyno++p
eJ22Q22nPuDH4QhHfF/U7XHOeEn0U2DxcN7s69iqIh9zx9LpGHtaT0IE/46XK5l9X8pC0AFXBHME
7hsA5ZEEYPa40zLMXqmkY+x3jZMkYbMpRBXzok21x+A1QT6NKNxjgpjvu34JQlj0xBs2CIhNW+um
biUlnrGPrTxz/SAtD02eSCtD7A0aVG3mgdOwVU6Wl3L7Hm59GRIlMC2YXQvUEtTk+ru7IhnNzoyU
I0a72shYqE5gt9aX2hK9cDXQr4GqlzQpAQ1GaINgMXvD8KixBmMvL5m4YOquP2U+yQs1RV3cELQU
n6JvdZq5gX2sfkYkdEteqCPjh65dqIXisIp8M8qnqPozN1yx+riXlEw5wv2R1Cm3kh25v5Wtt8to
/HxfMRY0HbLw4oMpBWMs284wtbno6xJkNYjvs+JVMpzK4sGXbmNFLAjFLsCzoH4AB13vXFUNXVBH
qXKs4hfw97nRWDsJRkcHAW/rZnW42TqEcxj/DWcEZOG1pFBRSrPRc+WYvOvC2nDK1RitsspFTk3Y
Tjnt15pEUmVzfxMX7jDyoDIakoAJm9Oh11KjPoSShpN2rDR9O5ajSjUttpz7QhZOCnYYdD3wtOAi
0hlvp8h9qA5xZR4bqatsI24wwBkj8qYmjDj5yUVJMIEoUILyCJHs9XJUuUvkwZfNY6QJGMhnhI2t
thitaeWgtbm/qIWdQ8epCMC+BiQtjNO1KFGpmzSIDPMolKpOkHA2XTQ3Rf/enOOBAlsOCkog6Fgp
hlArTTEI5jGtlWrTIQoN4UXa6EcT47l+f0U3m4e4F+xiEAVlmFshrldkCH6RgFDfOtaymJ9iz88V
V5DNAaYKzXlcKtFbcQDLoKaL6X9oDQM651pciPY3szAMAbE+OOjLgljeh6H0xNNWfZsSJZ6OY+mq
6NPWq5L4lbfC/3I6TH4JfQ5a+eYsof+4d/CX6AgCipg5S6m3tLDuEv805qC9mOrqK55Aa35/exeE
YPg8SInxAkS/AZuWMzGXCrA/Mzg9OhzbwftlRutFwZLg9vHLiDgoJ2/z/eq7skszDObisxk3ZjRt
nqKvMTiN4Q9Yko2mPgpv8UCzGpxyyeQq6kaLz0XwkPkjlauDjyHQg04r0+IEzTemGB+CVgOoC14m
QB8z6ilKaV1HMManRo3WQZigiaZqCrTGGhhJEvK67BekIQ+HP3gIohzPNlUJniQkYGaITmU3EVxM
gAo7WwzA8O7cV4tFQSa6bmdc7oxRu74GsLlF3FZedDJNYTdN/dpKp1+RGVPD57IhzFvEnCU6Q2ZI
nAIUBV6617K0NFFNNNlGpzAKjkPxnk4rsXtuk1U3/NIQKIo6iaRHOUArB5jsJ6BFUSIgVb7OIoya
TY73V34DToW1QQIGZwkvDifLzlfK0lYaa7GLTyOCv1VYR5lCLKsvSNEHWyuysqdhMNARaSFrHUk5
eo+1ONj0ndbvsJWY2qvV3EboGzcMt4FhKcjUIBcwN2tdbxGaHoMR1Yf45PXJOQexbGy2zih2RD7n
Fabu5KsMZWVEj50pBsQLJpLwnkm34drMoocElYiaE0q/7OSicdCSoEmqBLNAdnjCYgDuCVPcA3WT
G5tahhoKwLlwJ8ov2GO8AZGhQn8ycpnfdduLIBFMXL6JrEp8QvxMQrMiRvHVBjxc1IKtQmSIcAN1
EAQD7Nq6wBcrDVDJUyiZGJGQiXh2dqZgc1RrQdMxKxf2HLUl4ALYh1kRGaqnmX1y8uSUyoFbaUjf
B80m01aKgNnB+UiTDowZ+UCkJrQrc9cln0Bb2hUAYapwSL2Yc89v6t7QdrhyxCaziwHDAvOO0QOt
wLRggGCTIHm2PHPT5dVvrXe1zPpdFh0dPY8I43pU/lQZiIxH9/6WLG08wtiZyHouSbOdZ4KAiTld
HqSnbAAOWBrG0dV8cPDel7JgzcBPMUfMGOKKJCJjzaJIzXopbdJT2mH0Xhluxuk8pdGzkP5P6wH2
BE3sAMAic3d9UTvULrtA1bGdWe7WwqbxB44SLV0I5CBBt4FiGtbCuNVQmnpFDsP0VKFzgNa9/tsb
WvCOCxmvZ2/pxgN8iR43bB48ARu3YihTmbdlkZ3GlQgil15343E96CcvfGrlozCeS968jYXFgQ4P
IBYsD2gklqwY4NcpTQGPP8WdjJFXbSdgWoyyEeWX+wpx8wrGLRdB3Yo8wcxozSpEYeX+mKtRdlKV
cwMmYSoioWi9NGAsrJ4quST3xS3c+ytxTFDpVZExJWOWnUQtB7vHqHR2WzR/whGk+ElnVVvF9P/l
3E/0C39X6mFn8IDCGTIy9a6WPGmCzEj6M7WJq6kF1aZT+K+h0LMgGTcLEIh5iDX7GC08LxXUpM5O
fkibyHKl0Rle0G6WIYsg4hF8fyu/uZGYaAHi8EdHhwogM8zb0MvMSA16jLOLksnfK6EaOl4Td0e5
zgZbnMx61fviYDc+qohVIatuWckyNQR9tJFHHlwVyWuaa3JhV4JSu9oEaju9VC06RIW+KYdBnKdE
BLbc6xqJgijfiWktrS0Pk6Eqv0hJpjetW8FeuaE1jE5RjPGmiopoX5ehRjp0D7wk0mRQD5sC/GcP
I+4H2VNcSsmqSjFJpWtRbBTKxvYFOdgitV1sZaS3H+upaklptO3q/pbdoCnh0YCnQlYZ7705J8aY
v04u21rX+vF8+KXoq5AYIND685TSwLUc9bhaUedZ/PFVfcS/abWKnK9+1wOy63xyLNf36NHLo2O/
g1HJtkHrTdkN4/nNPuRIxTzG25CEKsGngGCBrGhFngOCJCWIAg49GTpnd7q/FTfvBjwkUWGT8TTA
jUBtm7HPfaQHneo1/VkAZHYvb7t96oBkttiF+8axVoPTrOQ1mB44Doi1N6zY2Q1eRDGejj6zXoNY
jXg4AHOzNwkaW3gbPP/M9QZjdXNq1wBkBA9zxplLfV0pXjv2Z32licTb+pljkex5skEiYxHrV3Qs
Y1ulxT6zbHBvNT/93+BurGqilofuNRr+bRPo97Ivvoe5q0IzNWIyRcMZaCyts3OjtDZSq/VfhVio
BaklAzPeKqksz9aIBkCxVwBbEvtWDomn5nhB9WqK6JujA6w1/s9XIXmL5Dhq1KxbS41I9pA97s8o
qMzzI+NtJRLlQX6s7YevjL50h+fokP+4L3Xe+tuj+SuUUTyY6U73DKk/y6vypXa9x2dkgzkv7iUt
AwAeUSxiHVw25p7jkd8LemnMWjY6MRK72gqIcMJTs5ty3LyBl3KYe5ykTViXBeS0tHHD18mtfkgP
6aYgDeUxrt6Ye1YWE+5I8WhgjDNk9dtsf7ZS8ljSnBh2EDvK5g3mY7sDiRxJaLszaWPrWzm1Ryd/
2qz8wI5+Tg6Y1qgT7i0n8mzj1O9BMWcbNlq/D3bM06yl+3e5Mcwht0OsJiP0G5qVbErncMakYEfe
6GRbrDzKue1LGnUpbP6YC5tSiZOWAAEyn/YbbvjhJ5LZvAXNu8tq7aWMOV67kOFF7WQJKnZ/Pufe
qanvNGuDCgdhW1AeopKnvkweoDTGMuj7793LyWOz81zHt2tO5oh9CrD6NBuHyxUBKIAEIISUB2lF
jc2/pY/7z+8beOYBWzFX7K9/P/H7BkBJoT9DU/0/zs+vevd635Isb9NfCcw2tfWAqbADJIB/1wE4
ZW2S1PZtrpmclfX27P/KYXZqbHWjEkwP+uU+viX0LSeu+d69pi4PPvdf7MlfSYzb8j2Ad4fke0WP
4SqyU5qRNRrY1hHHDd/05bKnwzikWhQjxSohqXaiM+anYkwWUZ91QsF2tfLtcldwLunNG4qRyFJO
jGVaaBGCx/NrfSrpn4k+pI++zVvX8j39ZwdZkEgUqHFn6f4AWzC5vwJbfPf2En1Bid6OOY6Mu6L5
Wy5uUKhngejNp4UioeOGzvj5INjt+n/bObQbwEEjLYiU07UcXRT8WpPD4VzYH/4J/rkgJhFsTPTg
DWK5IYP7PqQLUYwp7YEKK2PpW9SbQdycBj88lAiFB39Ds1VaU25JcnaRN5frQiJjJmrdl/0iC4Zz
tBnsX/Fh2E40IL574vX/LlqLC0GMtTC8GhSdcTKcS+cNNRMS28iAbO5bpNkS3FsMaykENN9i1Daa
felbgtuUbP+XwOZiEYyBAMy9MrwiG867ZDOtOxJvHhCjO/dX8d1Xcm8ZjHGQlElrhRZblb1V7kg/
gudDTTtECYaNl+xWpNIG8E0bNf4N4Def6rtBdaK6puu86y3+UtvjMd5stQ2X/2PR1f9d//eVvLhy
raQHeVlCWw7qdiL+arRDHOP95X+T7NxZPlv5soambVIVQl67jBw+0PiKmEWzK/tgHj3VHqhIAudh
+0QsJ1yJZzv7k6y4l56jrmy6tzJCzHi1vg2ZRcTDAXyfMSnW7+nm4YXmm9DVn3iR+YLIGdMHdOEM
MjQtRrkwZ7qORL/tz2+T6wIWuq7t/JkTdSxZGFCpAH4KOK6EFBdjNI3BT0IPTJswmpIr2YXb7eAL
qLBKnIB8efTz/mHewH9h0ZCBhDBAjgD+tZgQvYwzkCln0OVdjVZJPDkPbk46GwGpH5LRlWhqZyvz
KW2I+HRf9HdiidGjK9HMUgGuDbVMhTEtvzCPmJR02JvAq+ML3oIDbDnmIRPhoST4S2AbtHflo/o8
0J/x8/Cg7ijN91trM2ue7yYr48iJnr5T+fc+j3ErstaBvS3FzoBmimK4LcFQ7AfNAZKvdZ/NB+fB
e9A2EsdCsoOa8RqbzwM5YR2UG0g7Mh4m0+qqzEJYMAAk4TYBvHxwE9t3MCzSmHHY2+eeZFvBBhE2
Xmw8bZh//XbNf6Uz3kZL8dCuvBRrXsmrg+xIa0TxzrAtiPGRrfIfPFj9TVVhXi4IhgERQBQMyhjm
JRp7Rdd6AFsjHkGPrN2u8G4g2lbYzj6O926QZx/GLg/FVxTI5oYP7DP+/cI8Vkk7dLGRzz7uYOxc
V3HlrUGix2qHOScPwqpwnPUpWwXEoe+gUHvhhsrz/t35AHa5CCrzoJHwAQ3enjO4KF0Vu/iQ9+Rh
m5Xo0CCgbuLY68U9/uZbn/l7kTRnrvgw6Slow83hbMvb0VFcF4m9h6NHtv7v+zf6hql/Ps1LScyN
rlGIiELFG87xeiDtKoELnFwgqajioxkblF4kPk70GDqO8BFR35Z9kpKIro2zdMw5Xnop/Lz6GOb+
aqM4ZmpXjWfLG4ZtVijxByaQq6Qou2CHRHtIPTMNAFFOq5UKbqm118c8lM0N+o/dEeY6o88j7PwS
e688R9YGw1CajnQq7dxWsxPN9d6NkaKfABTZr4D5JCR2NdMWYdR4jb+Lhv7ybJir3WLOXtK2xnA2
SlvYqwPNlZWRr8HzrtvisD1EAR1HjEvfhM0uofJKpOMvQ7Hva8gN/Ry7H0yUWTVy3KLWggAFmmjr
dueQvWdjT6i+QwRxGo73BS757MtVMxFnllZqZGZYdWPniIh+vHerkfAWtRB1XWkaExhkyNfiVYBF
KSCvVYgsFaTvnHBTG3RMSIoJFep0lKwfrfUZda4ePoXNWRTtsjmlWsuBwC/kzq/vIGPjYhRftCSb
b/uUk0NKppZ+hA/R5pBtok316TsgSzLscGOs0L1H3rWVbDtmSm1efmNZ9UFLik4V4F7R2X5tbAUw
0npa6I/n1+Htwzx8ALdp/UxWDzZBNDxHxKHNSwIuq9eFTObOY2C30YkRZIon1GSo9HwI16qjpOQY
gMKkx/E8gIKB8tIFSyHxXPv8Z63MNRf68f+qtaFFxKjXgrU2no3so7FW6mC3laslbtetBDeNaZns
zMxVTFLJL4q0FSIwEf/QMRmmdi0MRZ92RlFjiMChiTeYE+k/378QC0+wuUEPPddwtzNs8vpUalFH
ZaUMx7PiqujssrYPvCwNTwJzG6ai7oShD8Zzuo5siyYP1Pq8v4YlN365BkbFJbEdLRGN/4iRlF90
WPHUaNFo/LNHwLFc75EXibncjFiBPWGTiseGvFPv1/01LGWY0PYOHnMZvGfol2TscVKiNoOHwHiu
t/JKdTRIeor3Fv2jE490J27osXAsV/IYyzuBIk+VBciznudsPLLjNY1sfeOvetdaGSvRFcmncr6/
ygXLOJNNoE9bwyBIUMZe72QsKaNWjSjktfIpE8AKaz2olUTaZg24HdEKDmfIwsFdiWNUD4wdudVE
EKfgGgqmQdTs1JrmjL4iVvrDs1qMUn69v8Sl8OpKKKONAKHoQVIizijs/LVdtYcUT8Pf9V55CW1e
6mG2I0z8eCmLxdOOQpNaSYwCbeBX5zjHMKCRh+TmiWCiRbUd5VFOICLF8L+s+hXxeLEXBWDmF4ry
0H3oxrVOYKBR7bezTpgxAlHMjKv/LXkFggx0LfyVwHgBUwiNEHyu49kn+Sqwe87VXQjir35+XuDF
KyJRzFYZFCwglD8EObYtONrQ4F3Ypft6uQjGPtRCW/iYXTaetSQCqXdGZC+mTWYBtfpb47VYfHf5
3ijWxZYx1iGREiOcUmk873aH75I7ct7n5Pc5p2RDfu87Zx/vyXtvP9DM2T5Xh4xmh0/kjMn9y8Tb
WsZeeII85FGIz0BfFyaa/AZYkjQl7x3I00DGTNSJlullIo5nkNegIuj37qDLHCVRZjW+t6OMWYis
sB1zvEHO2FC3fwoJXvHEehhI9Pz0pNR4D+0zsiXPYUbSx+cv8+lrZ50/d7zpxkvPoAttxczfa201
QErZDaClQkgE0OwmfeoepXX66SNJnnNOb3FflZk2Dm/rGYx5LUoN01YEZn48e1VGTOUzaLmB1qJD
uRDBXG0tMkM9HSECIRWK8ofHaXPO3POwQ+5vtXL2vV0QmWCGM3m2Nl+fHFu/qJ4X0pmbH8R9CXo4
nKlVvWnljyxzUt7k5MUFYveQAESXNwg3r/dwGCNtCNHScpbl8bcchei5Gqg/1J9tKTaOFIO6EWN4
6P9w7TBPBxA39C3fMNSoGIUwTGE8navy4MUPIKiQhIqjHIt7dyGDWVibN1KY18l0jsxfOboiLHkr
+LyuWJ4Q5tKpVuIlohXBdFXoRVc2XSE5JcL/+9u1GLuBPQhgOWArMXyaUfTJKKZWmvLpu4q2A8cl
Abcm9dyMCBgyPBJebWYpcTUzxM+5MhEvKX1e94XLQWJiNMyhmBDxHjqkcSzS7auz/PrrMT+5pLT3
RkXeq6f0iBa8zXNG16f7K17K7Fx9AOMfVG3A5K6kns67tyEkPiK54+gcfhWum9KnkJa209pFSbOf
DmZPVKhQhY8oyvJyOt9F8RujerEPjH+o1cnXlbqczq+vh2L/UZNfY059shLoimTEPz7IpFvFdkB6
EuFZwLn+i3fzQjqjwuYkCEMrVtO5K06q/9xn5V4sXtCw6sgdglpPcji7Pu/qveUy6jyIljeKDZa7
A3RjdD4eLfdXfRjI5k9IV06EHHRF8+fnk2CfeJ5YWbxKfxfLAq61Nm5T2Zpl797M1Uf0+aG+TIin
NmTldE5vv29/Pm/79ddWJPS9c5yXiPCKIYv+BF0z3/ON5Rvy6Ubt0fI6Zthv+U8uPFXq+f7+8n6f
uVU+WBqEosM1jtKP2HzRBU4xZ+n3QYiDrp/5nYf+xOtbW0VyLQ2NPp0NPX9TgurNyof/wXKjUxXE
gRbAfPINTDHupgn0etPZK9FZN25a7TUf7fvbtJRVmWc0/CNkXueF9ZlUq44izIE6v2quTsWEoD/q
+fwjBb/CsXF6F2hMdLwZZ47Y2Yqy2g/+QPhCcI+Dy4e57KIRpXKOHptzHw1CRHsL3D7U960mJ2qv
lh6Z0jr0aKrAGO/00bIOYSQZCWkGIDdJGxaJWyb5JHGsv7zwXZgRgRYTtCOg34T9rlDHoBVAKCRY
f0GmASBcbnlID+cJlQThBSXXiGytLaaSbNfrdv26/vfboqMDCgxrGM6IzkrGKGA6e5r60SSd7beD
SsNtaSMk/zpxbN0S1uZSDIt8L010vGoTVlk6KQGmJ/2oHP+dj7SZP5c55Ss5zCXx0CwERkrIEdaI
5w6PvwbyZNBp5cC4kefTmudDlpw3oCLfM5kxcwWUw9farPh+OXalJp0BGwWb/eNmBWO6F11ny7mb
t+7CgHaAKAI9EaBXYidomokOarE2RhrJrcn4vqcTL9xZCO6vRTAWzDPHbOirBMH9dtoRZ799eObx
My8owrUMxvX7YGMQSgPLaFAZLumG7Efb4WzVQhLlWghz1+UQ4QWaxvBaQv/S+wMgBNQGxIXn1bgb
xrhwQQRIEVEoktIHxUa88rTjGEveoTO30xubvGir+dDr0/j2rD/9//3+9wIvbLE16LD4OX6/xlMy
I7RZPXPsy6z/1xfy6ihYeEeodEAEdJCgYaBY5IY0WK/Xn7yT4OzTt0JcrMMvprTsNBxE/NP6Gbpf
J84+LQAprpcxL/NCQBAJaTMBFYz3t7ZG2yOhW2jVSE5rjqTvIQz3Nky9lqRF4NK1VEiaHg9vLX17
+wjo+jGnvx4PbuH6ZEht8xFRGicm590ZNoMsFn5Va/Pll94+jh0he8eJyAvnZt6a53kb0QVhIYUL
a8lcmCzSm9CrcrSEAIwBw4wHBpne76vczdgCtANdCWEuzWSVsoAW/W9L+fL0eMbg2PXTk39oG/tp
f4onG7M8fUBXkdXlSOYsT2WyI0EXi14lQ3Kwb5+AeUFvDgnccNWsTWyp9LQnP5x848jkBThT4/3L
n+wWTR8K9z4slMuu9oBtwyoEMENXIjb61Xx5PcBjuBtyNOi+cn44D5SntP/FEP5zriyrW23WFpqN
IK4sUd1AKW53sjkXY/mK/xXB3MBB1atBnBPjdkninP6gmAOhcg5woax9vW3M5bMaU9b7Bgd4sF3X
/SMfV8e9Qyk9RfQ15cTz3DNi3O1gBIYxovl2zulN7qMr4ZBW1Tpb71GzAR3SynR4DUG3z7Dr9THe
txOTqi9QQzlPu9al1vm+/v8XK/n3jBi/q4FgMhvTGit6ix8OjzU9ozRLgnXxYHNxKLev2eulMKYk
BrYuknPsnn0Y7AjgFzQ9UOI8h0CYWTbPASwUwq/FMUYlj9TaE1Voxm6XEvuA49psjh1d/WnWT4gu
t7aF//gp7P8SL/2zpWxzDZiH0YskYJmpT7WPLVTRBFCsXnOUkXO7WFRPji5LzZMgpsqJuNEf7XXP
AzbIc+x969n+LmV+CV340DEdw8oKZn2339yaAs2KXItuE8ehz8VqfeI+OniLYkyGNgZ9PJbleNZf
NLwy3U1K/6j2Ck1w7/SF8raQe1SM8VB0qTFyDSqS5SSy/UP9tn327dOJc1QLUMIrVWRnnEiBUoC6
GHKghrAZqAMAGbtyqLO2NhYcCuftxvOnGmM0IqOcLDEp4EtSAHS/fcn5D/mN/DjeVHTt2/Ynx47M
fvKepjB2xApUNdR9SIzJwe4PtQuf8mhzhHCcNTu7MfKQim0LaMebDQzbmWyQ8yeUbrfrnenwAtSF
nOv1oTH2o8ZAsl4ysaQdxH1AXuA+kT+eu3Iy4ANxr79On58ih2Vn0dzP1I6YcS5iPi2jkWiiAsPg
BE0xQCzx5hFONLd8oy9+n/Fg4GbPPK3DjVbIKzoYPj4eN0joqQRgIBNbuV5zVPGGJOU7tLsQyKgi
WHRR5AwhMEP5y6A/5oc9dU2ne7+vHPPG3CjghRxGAUHOLGpdi40Dd6/d/7j/4wsZMOjCxa8zrqvQ
q9QQku9ts82faIXeS1uFbtfWsSfcUHDRCF4IYxSvNcZa78A4cfZBNPaOIiEvMbFsj/5KYGEEfusL
uRFhOQVySI8w639mc4TkQUa5tm/RMlzIYvI7nTICBOnhYCzQSxdrVDsDcvrkBRece/Ods7vwVE3y
/45feQ5XvFmQC9WPq+P/trcXv44hiF0Lng7Y091/EK0f8do9l6vNCon4/UR723l4SO3UXeOVx1va
Qr7xWjpjEwxzbBrZwg7uAFqeNomELvQKze9uQ2n9y6P1+nP9/CLuuC1B8525c6fYFsU0qZqknR9H
UUsT770B5+NjJ7uBwjF6HIX/tsQX22tlmBHn57C0xqO50ZA15fjf5bj9QgcZ41BJYPZu8nkHbdQy
EOU+4m3VoJDR23Q7rnl1C565YEcbVl0m+nEMeY1roJ3B/Y+RtR2Nbu3/KQtwsTbGWmhWphqZCWsB
A+sYVFq90+3p1HDM6/J78a8Ytj2xAtdYgXGzAL0MRIQqgOiOogdeNngPujnEu6N0bIdib5X/V+l2
tuhoa2/7WL69dB9oY+J6+MXw9mJNTHg7hFIupeWsFil5LUmzd7U9ogoD6eCCUCd+23Kf3fNP3lsd
E+COSePpFhAMc1aK2DUZdtWzdRABdvF5Gzkf/D1RjNmoS7lNtQi3Cq+f+fHzJ6Y1gheHrr92Jx6j
wHIS7GIvmcBCNKNJ1jwszEat4OCmDqBDm6faXr1vne1Intd4nuw+77vl5TgXWSmQlcxTT9gCm9wN
elNIeL2CeI08Fs/nDd4n8oY4OL412oK/vvrvjB9H7LKz+SuW0ZsiUITClL/Fvr096jSncucgqKfa
wxzU0y/geAvgzMU1yjK8ouJC/WJ2B3+lMyoUAsSfyFWDshht9tH547AhA4X888MDj+Tyv4SLf2Ux
OhQpceNrE2TtXneNPSPDQuI+rRqUGmA7HQTe97d2OZ1zsThGjUpfLcX/Q9qV7TaOJNsvIsB9eU2u
EiXZsrzIfiHKdpmrSEriJn79PamZadNZbOVF9zQGg0EDDkUy8mSsJ040eKYRJ2Dz3sSQgI/811bf
cGRxrYdxTRXsmAFjLn3VRX+Pmb41dYYj78V3N79ceMOuE3C0o3/xzyv5fZzMO9SZXZYN1PvGSw5+
4ZigdcP/dfIDLrTN48y3JMZhxXKkc11j+cDjc/NhEAW3Y+GXwQhP/2WF6pqtejZqa7fV+5tn9lso
8xQZyfm/ydSz2zhhgg4Vc0V8zLq2tv2pLbax8/nM6wjjXAfU2XHmE+cBG2/VzqK+7Mlx9qK9NoI7
9FGfncFvOfr9zbP+P/1A2vxTlJwYh8OBxjJv1l3kLIiKnLt9jah5jWZX4uK/txQsLf0pqsFuDe2U
0ODT8Zw76qI/HHwvDd+Q5EQGBvqtVm4g2fYucLafYZA62+KJl0Kbzw7+dRvBk/7zVwDSjQN4/umv
QBPjY0qQjyHjEvkD7tnOv8XfZ8sgTScYgmKcqMGCmQCDlmWAANvccF6MK1fzrXNl8MVUYqU/9RBj
5sRKMH22v9jKx4E0TpHi/9HRVwysncmiNPEzFh++v3pdLhEX7VyXLBIvcj4+XjDAskc/rLWtVvZn
hKB5uXQRPrcVL1yfT1BNPgADUYIenbOIZredfefUC0w5C3AbeC7kfIj2ffYMLKWYwhwimnSoMHJr
C2+iZ28DHqkXRZxbJ88gkiGVlRnTEHpcHJ2IBF+Ry4Gf2+iKvRg/rbWL5UY+D1AjJ0gebvfoVVk8
Js4DpsxIg6u6ce30HqT1u21Y8aBh3mv96wjZsmwGbkxLpBHiGlLPtuWKH/Yy5u73vg3rxtVeJmCX
m+c8G2hO6hmZRPhY8Fb9jqyQkD3ZO5BC8Eo4HEg32DJtdRkQ+WZIuYVvRzqKDQfr4V4Hg5NMvpYy
We54jOE8k78mlCYqtvWAdqZrLVBfRj2RtsAB7GfgJre5ghjEaRKxvjQ0rK786BXPfdAHwY5rGLd9
RawJ/GmUmTjk2MkDw3gOa3CgWBvxNd0V9vbqG3IuAE8WgxadIMepJlDreF6vJTz5B3sgfm6XAWrD
OztQXg2egcwHGd92z0BHDpJaySpxiGGCll777MSPWx48ce41y7kbF1nW5AeotXbSAKmPu8P+6/hS
uDuEFJ88f+K6PusGTl091In9JY3Sl1IJix885y3E3OT67nHxkK5/PxZ3D+hNuijk929C7DNazMEk
Zq3CXb67BAHvZDmu8B8M/dkZ0WlJr97JCfdvd97jfXfAd0SKyVgUNscZ5t2GayQwUfuipGNxpGoL
gVeDGTpQXLunPDO3bZTzCrB5Oi3NYk2kVW5waXaOujZrMhaO6NyW8jcJzr/Mkk3YYQPYfwsunqcF
KKRb9gOxfy1Rw8fd45kM5w5cQ+PJ0Y3x/4AkXKPSHd2DMI6jDr1FN2ySTcR1DbI8Zx237OI7SCjd
LTKvCT+A+nTQgdfrzUERNhs3FLU2mgMsIV3+xqg4xwPjfhoGMbT6oMRHWkN30L5NnxO0j/su/TKo
vD3/y4NjnI5kKHq8ltAFTARvj8ibRqvVtcwRHt55MdfflDq+jY7xPy61lSo1te324Iga6F+DTAuK
YVVYO+UIWz+qftk8XDDwdrZv68m5VWxyruxySewkqBn2X/LrafPFubUz883TnIPBJuXaNsVyOOo2
H36t0X2e2/7CW6u+B1N8iH2Un8nGxSBTT77QYMWxfq5wJhaqBfQ+n87QrnL3KFc8vnlOqK6lo9Pb
Y+1G7da8sy8vzjb42hXrDKtmSPgv0ZHtGW3aTB9NdEoAtpx4eYCXjHaPAv9wdP2bNOtfNnSd05tg
yalUpOGM/VuPYfoLbWRYpbZH1xpHCs9cGJ8EUV1WDTSOPVZ2HeikerzwesY5mKgwrsglMcxUzNG2
gqg8XRp+wEMpXtz/xxrM0sq0+AwJ+/VhI9pvpEZOitiGLyxuXy5eFMy2wLWK2rQ6JRLp7ZMzrGKS
+w/+/eb0gMo9R5R0G+jZfUZx3uZ9j+fk0XF6nWCh1on8QiYz8W/L4RiAyuRMCuHYNukIjRBMVqC1
RbDCWxfDya79QSuuCGJtFhckSXsbxDbOXYL5HPIb8TTBFOkmu7YhnF/gwXHu6nzIglW2YFHCEB2o
/H963HIsRUZMYdgKnr3cfdSd30jUuKja02wJv6d41j2dyGNuUzQI2OpS4ptpJBwC6yl/v/2x5ut/
EwHMXWowGoGdC8CEPaaAvLd3BH2oOhaEvG5QK9uG/8wKJwKZJ7pUDGwNiegJksXCjzx0TZHI5S3M
nPUzJlKYt9msD+VQpdStHx3wxHHMYB5JJ3+eeY2TuCgSrGXCVdK3qV+Qa0mAA6Q8W7v++wlcF434
32BhH4KlizbH/0Y4vrJPdrBDZoin02yW4Vsn1knvR8VMepodT1bv+DTGyT6FOrhcLEd6PfMqcbMQ
PhHGPLvYKlTK8n+EOevCEz8Ch6fPLNxNRDD5xULPLSu9ZjlVW3p4QZYfASrPPZ+hcofzMpHCAEJb
dOdDquDUCufNj/3fA+ivCOh50MIT8/bDcIUxaHCM+8tFMSHM2e9PqwMJexv7FEpPfRXNu+MiOLfe
bXiYfwgn6rHwcMTC2VKFxBxM+ZVPkB0mKJgE2oJn7bzPxeACdgzClaYNvSiiY1AHLVG+hpLzCsUS
hKXWosfg6/Nt7XhGyICEgOaRsmroLVZPRMgxe8ItOdHP/0dwNTk/BiiU1Ko7ixphuUjXQ4j9Dugf
/qLOXYb/ckz+GqrdkMa66u046EfLgrTnNfL6OEJwyDoPIMDCP6g8UYYFrBVoiYiS9O2jnC/RfivK
OvG5nAvZxYKhnEBTSolKDeRJsQVtV9/F5HL/0Xvdclwq6ziHCx0Et6XPTytMpLNwkh+r7kD7VcO3
w2+s04CFbk33mUebMZ/ImMhhMAU7mGO5GnHAColAab859EReLYNdykvGzidoJpIYXEnlxuozldrm
mrYHgkk+x11Yoq4W8Hhf5qPmiSwGVtSDctDEBD7Aydm3LspceJgbglUUGJNDCYjzrTi37g/vvYoT
S6XQ76D18T2G47Z4QCEErQO1HXLxebb8MNGNgRVN1yKhuUBaa6+xKdGV/MTl3bt5J34ihAESAwq1
R5o5b5fFCmsPvpRQO5A4AiOY/RR8cX0onlIMqgxtJIqpAXnX6enCsd6E+9tfiecXsl78mCtUKYjw
7g4uklwd+UCLr0k2SPVuA+XxtjiOTbDzKeDcKU0logqtC0falER/4GZQOC4hO5TSpv1FbuihocuO
PPymowguupXd7YnzaPIEMSBR6dbZMLCQ53EtEH2Rcjj4eH+dAYY6U7AKiSasQx18pufF7Q/BQ9Lr
Joyp0ylbdXmW8edbu186g1M05GNcHhd2yHPR6aX487HSEUlhxymWHDKYnWrokDpmiOHM361jVw52
OfBW3dHLfUsE8yUiQZcrs4QITwrl+4LIXHjhKcF8jfOIed9DBK8FLc/rdfuWOQoIG14upPR35zt0
QyFfxPlC847S97kxaG2aeX9SLhApvxWOuljdu69Lm/Ogzsce2N1O6WxBnMvOmUijmUhd3VK/70Au
9hr+GPplGoL5J8wB4hni+A+zADCRR5WemJ3UK4eGjjo+jh8FBneUJXCTc248EYy9KacuPXZWRz8V
+ATQRnaHWYkFso3It+FhzXnViHlvDPt9FAvLz8A7ygjUzhe1Gik9aGsfSHomY0DpRKhX9pY4ZhpG
H8sdZjRSr1wrWbjlNbDNmuZEPGP8Fz0quzaB+Lt4CxflK+Y85PNJmIkAxvaFRDc7KaLMpCRZrRP7
zsuc9mlBHsRPdAIO/g7DV8UTLwUzH3tPxDL2j8M24suoD4+DM5LDU+qjz/bcwKvl6DdrLxM5+k+T
LK1BEA+mBib6ZwNfzXQud8cXjk3OPuQTGYx3QlsMG+MIXUInAmMR2l9Q9tZePzli6Jf4AwcnYqip
TG5Xeq5OiVpAleNDimUtD9ceRpSsdheeQtSmb0mihzqRhHJVXxgHKJR14CRrzjbx8t+xH2sLXmh1
LRX9vSiZ7c2SNTM56iPML0RTqP47l8F3rab+KUb2vEoINrdQlu/EEzefztbIMJsdahwTmXf8/jpY
7KX9qW6ZNufzRcLBOk5RE4IGv5KUD7sdd90Ox+pltmerBhdLbkUqtK27EJWzA7AjMBZbjqXMehcT
hRjQ6LOiF3Kwgj1mhReXMcHmb5KBxrdbqCKRpGXqKHoYNfsnYbxvFK83F5wfcNtU/+S1UJpkLDP6
VdeiXb+e000B/pGLgRxh5Bo1L26db7ubKMygyYiC4UmycK5qujDFkki53fryx+m5VWwRu36PZPCX
8ucQjq6W7HVenDfroUzEMyBj9UaElcIgVD58pTlJ75cx7ymfjyQnIhiMiTWQ35wz2CjmikHzlId4
ygmW2BjLX4q7c7hDWTyVGLDJtTIWjYJ+Qaf/daSyXGQeBvdEApsDbDJPFgM3XYylOSYWYKJlie55
qFzsfnGqzfqtHW1zR6rFalW7raffaSeQF+QOL/HAkX+9tRO4S086SLbPsB5sJX7fuHiGbl8HnoLX
hMREQHs41r2V00dov4+Wi9QFfnvyAoU7muJwqiAMlroX2A431UEt7wa8ss1ZA8iu04peDGddfy4G
8tj+jolXB5Fqg1o70B5vazofeHybKduaZeYZOoyGq7yK9G6CvRj5SvdKpMk4km4/7Fga+xO061Q7
mSrFOOqXXWzdH1Z18FEQ2nG7+VU5OE2OdzufN5oox6BMVelVraa45pX7rH41y7ogS+4s122HD6tp
f+pVWOm5VUc4fJiAFz5Ue1geOmI+3D49zgNxxdOJQQ6dOdYZvd3ew9ftvzzf4jA5JAY46rYvjjVd
Z3ByWsO5pHb+YKj+KXK7I6mfrTWaotqg4vHgcQ2PwRDzKFRl1+DYkgROHvEBV+j9QmKPNzTDuVFs
PadVTsOQ0++T/8p246/g9vFxoIgt3yilniriBR9mHfme4R04UMsxLra3yjTyY6rSU0LfX47C/itI
2W4rwLEstq1KuwhSXFdQIFpg+uPM2QLLicZAgPrzdkhd212Mnt6O/bpf0m7sZlWm3rmwQSiJVtPt
zrbd182DX2s8wJmN2L8Nm+2wwhoi2dIaCjjLvblFpFT3zidvFnY+ZJ9IYa6/WncY/zpAQbAsS94b
JTjwQaqM8gn23djcDkJ6Xjfeh+vLNQECUIekfZrT8yycU0NsmeAckS1GYZLrZvMOkEEGSYgxhyUA
GdoT2e+rw64Osucx2iW8mI8H1Nd2oYlWuaA3p5bC28k7ryMkO04+n4jidtQns2UaWaqiWKHbUi5Y
tPRyXB87Ym/5YjhXli3JlMNZNlsZsVi/XOu2eZ/bHep3mOe6ODi5ULnn9rfy4iGWu1bMFbE4qBBp
BMgYuwTTDIEde5+8ti3eW8H2TFmamElneqV6zamwRnez+9Q+UVCjdcJ/GROxbVNar4jjsYH15Sho
pc8dtvJ1TodVYhdwvJ2I2Sxd0buNhVcf5MbtuhKoTu0wzas4KiBTaUEe8lCQjwZUTaAe4rwaHNBl
izFVq8iqkGGpktWQNCJnHqj/TXyFLhJsajEtlZ3yOaZdV8oWlqaALcQpPeEhX7/a2Pu23KWew+Vf
nC9bgNTzf+IYlG+Nymyx4Z0WEuhE4TYPH82F+pFiVaHlBMuMBLtgy3ka/+ZjfQtlvLu2FiXrQJeS
jHeht/AEe3zAMvsvLsLT4PtPo/iWwyD8+XLolE6gZxmCnPNuETloGaeMVCdsawOPHlfgfDbnWyD1
OSZW2IDKsk4iCDyhHZLOv2FAkxJoUk8Z7wqeFYzTOxzTn3dkvoUyYC9iJqlVTJjkcwiR3rrvsWvz
PtrJjgg6fXt7DHmbQ/8G9b9FMi7gUTw2SS/iA4Jg5kzM+xWlugPJF0ez+SfzLzFstJiAUW880cDj
uVitL/boIV9UrS8pXTPMHQflGMtV58m3s86CosmZQJeDed5b+aj+ynMSeb+q1uXoxbt0bKgY52JT
qnRFFeaG4lDzPIyeBwuyRK/B7mnTLhR4Brz2nnln+vssqfoT9YRailSzgpUcDCfC+ukk5WjFQy42
TDQirJ42Ogol2LUqk73qo7L73Ju+7iGd7nBeGZ5tMBhSWXncFzLO0Aox6pe+3Da961t/AzrY2LCL
lLjMtStEOXt5iS3aWDL6Tim3BkycpHaD8fLVYYHengL0W07hY+7z9k/gnicDJnWj1mk+QMN6ddi8
lw4w5LxavazwHAS8ttrZEN8wTGy5NLHolHX2j1izKtd1hv7QM/jLsEnBA6UJMsC3VZp1sCZSmG9W
DL166GVwZAqNXWjusXI1LAHLFlkdHhqOOc42qmu6YtBtR9iyxrL0g4ngmOgXOi3vAKO698oGfRnw
39r81p17tCfHXhvGnr75jEF4arqczzd336bimben1I4m6lwQjx2qFTqzkt+3z3K2mjQVwJiHFKUX
kI2jAhiuvXfvt75oAtrQi9JmCWP8fBa82wJnM+pTgcw7IxmHUu8PqAeCpyhU3TpI74Pw+baQOQuZ
ymAelmFoVEtMIWO/95wB/FTZkRM1z6YvJiJYKv28OfWZQj9MuK532cvxA/0Z8dn+5C5FnnuXp4Jo
kDZB3K6VOjOldA0YU4iWkXOPBqGCrKhPGugu5+CoObF4NRVGPZOJMHNoByUdIOzsYlzb5b0es4GK
oWgaiP8l1LfZbIkUtxJop0Xa5mBgIltqiAnitRN02Qo1wegFR585Q5jKY/TpZLRx9ynkKSnJXgqS
bEvwot42ttkrNBXCvImxdOqHToaQk7cP4a217lv5mrry69ki6aLRkPTvodtXEIl25h+5xBDXV4T9
atMfQB+5yVfr4ybVNWEESOTIr6zfjz5BGCj5ZHSDQOK0KHG/IQO/517QUNiAuhDmrh1wu+uPNHl3
gZYc9Jt18Q1VRm1Z0g1FNmlIP9FMkSVhPPb0+0GxvfRfEMw25PLCw4xr+P/HKU5kMRftggGDQ3SG
rOfQIN5bfW8E2d2AWpxzAl2bs4tcNAHubN0DTyAeNW4eef5gJz+AMdY8xwRdL+EHOPu3CDyIiDAC
eMMGz+eZu+TTQ2XsVY8PlXKoIScE90v9Eu9u34fZOzdRg7HGKheGaDjhzxeIk8RF67jBicvxPJfL
merAGGGbVBXINCScFbq93hYk9TtbdVYvJaZp7ZZIi57jKM6mPqYS6alOTHGMq+oYVZBI0xF7zxPc
s0d2O+4MFE8z5kEeUrWXsSGGUjxh3tuCFHupPtz+RLOv11QZ5hFWjcsgFchbU68GI5tYSK8S+YUD
jLOu51QK8wz3tTTGaCCAlBrdySPM4WCXoe8+LYPY40EFvR1/XF/4aGiaMk2MCTHC9KrEnJWmQFhD
l2i4EgqfAQCRc3LUsG6IYZOIVmRlqiipEEP7mfaDY2xUgu5y1Ob+0fF9a8QmEs9DoUXmaFCNvHXp
oBZ+su9tksCl/hz+H33582g7EcgAUJzIuazFMh3vwgjZ/l1xVKdA5+kXT7XZtnVjIomBoEMhZlae
4xRxlZBtSO7PYDUY0UIS3ouoXANf050YQu6n7vIuMsdQ2LxiZdZnMzrqoNh3ovvRX+2WwZe2MG3e
56PvxS1LYSAKDPRWPnaQE/ZLy8NIwMu4leythpbF2zY574BMTpOBpjSV8/PRwmk+58jTo8HOGzDP
aNm+729w1762AY/BnGsqDErVelMNxxym4pwc7drYN3iKIy/KZ9lZ8k5yFhIn+jFopSRybCYNLoLT
UR4DZVPtBQ0oz23w5l1uBkPUUT+WmQmMF5F06BbCpgjPH5uvHrnLI3dLDu+zqYxz0wlSnR0GnOHx
TXnB3JeqkMYlT65fw8FvQIURmKq/RaIdUHPkZohnn+nvQ2V7v+shU1PpBOnPZxcrxeONt2595UCw
c2rcvoov22de5/H8qzMRyeBLBErQUsT6YNo6BtB8eAVqfmENxDP3Q3LuuMrgS3HArOjxrOFoXUrv
WjdEcNWX4PP2xZsLzSYopqo/XQK0RApV1OPeHRU/bXwB85QL8cVq1rfFzPpr6NfGwjFsctRE5nrD
MTbNUTbReeyPm4A/Gjp/WN9/n7nLeSPKeqfj7x9dB/zRdFlG610czKHe1mPewZ0owtzjFCQUXWRB
EJrcbSd/iJfxehRtvSWn9RaV/432OHDa9v8GqL6VY6600Z2KTFIgUwP5NhFdLHJGEfrDJMvkSD4/
uawCszahKzBjUcK5mcxhqljk3EXU8k7wTN/Lu8OThrmKBqnY5qm2Y9BY80cuqQ5/vDS6ZZro6Efu
7UqQNnFNZYwlNFaE/aIgUwD/t0C0IJFseTGcsCDnQnIv2Ba2LNqcz0nN+5ZY5jonp7GzUjkb4ani
jkmZ/fJkB20YKFxg1uh9vSWKuc9Kg108cgZRjv5WEcUrHSwf8R4wJPHyGwXWe/fl9eJJdkSelssl
Ok73NLSBC4Pq1+cnuNzszStiqS2AhvP2ztvX5OwZDIiR8M/NCr9srQQaEG2DBYqgy5AW//KwGW+i
FUGzJtJvDNXW1VpWSLywa/tLua9C3eUIm30HJ0oxiNOrnX6UCygFz3OPrUdIJmwkHGBh89LTs6SI
WNn2l+0y9yUak87UL1QUWHBMf69gJ0Wcu9EqoMw+QWCD3LYheo9Bf4z6U78Qi6Uw3tGGiMe5+alZ
qJ38GhahjCTWChFLc/fO2xgqrWfZ1+c/eVJjwp1Yurqat8yaAadGMBpJViCOVmlHJ/EWD4vkzixt
ZMXSzAkAipFtykENVgqY8W5JN05tn3ke8awr8K01m8sUeyWR8hS2hU/Qu29nbAiLVoqP6XrUN+ke
r89/FkZNRFLneQJZ4zkzL8UFmkc58Y5LMSMCfBDfTbGtI9BeW243AefLGgxYxVGCcRsBAkPVh/Mh
HVBzWYphig1U4Kv45GWT5tMFEwUZxFIzbAodOyoPbfLZ7nIXBCDz5KAPB/gNBnzyOh0qzYAQFFAP
oBBFmZabf+ZAr8EAD1L1ctY2MV1THHqWp4m2i4cMvK88TgwelBoM6rQC3k7hDG2e4Y9ip8pAYvDw
06F3zrFd08w37p3BgM6hNzp090a0c6C3s5WBuSSgDjK20kYEdfd58bVFKSeydZfrmXIeTYNBGC1q
z6JwwnHmWNbhpFvlgc5dYvzELgXy72DcYOAlU/UYF5vKOpFwv5ZLW/ysUWLHClOiOf8sJvw2eTZZ
W5dlY5Q5faTfzn7+FK9BwLgDfVNPhBUv2zPvZv31bJgMfqRlcqj7CpC1BmZ57yUi3jIEx2m6C8J/
6CFPNGPAAzO5l1wAuw5tYkzuRoTUOEHe4BjP/k0GMobBks0qpjDs5NvBQF0EDZIO8gW87RNcSQxu
tL1syu0J9o8Rq2uaEfxHKxQLQi7O05O5cdNMBj2MPM6VTE1GFJTQOwNqKkrCDb+F1zPDw1uTAQ+5
rAshU2Dr4f687kgZ1AR8RDJ3nnm262LisLAOfqRWZXnocHYXP6kInLHUFVzDsqNV2ZD64tQnopPz
Ct7SZ5ikG6uzb9/qazPfrSNlEEQwrCrKLjATJHswIqrbSohNyoWTuqBRW0RHOwLZsdejMVRO3dg2
A7yoMXwJGu/wmZK4tsSATCvJh1w/4tZflp53tK0LVsWDW1lYoEKCrYq3lZ9PKX/fRHaDcT5KY6WI
sCckKNdYGLUAw/P64cUk2F1mLT450qjRsEdtqliDoSsm9nBfA9qJl3JsZa0bjQLuoOJUawWDgn6Q
3pX2Z7b+RJjDkTZ3V6bSGBMekcSrOgvSMFVDSie1Xy7wTrgR6lxeciqGefzGourQlXK4Og0CycEH
GVzeeTWmWbOYSmGstEzKtOy1q/+DBv8UHG4gp0c1i1sgn23AnkpiDPByzKS8i6DPCeXBZsTKN8y1
27TREfHDF2IWC+tGed9qLkKaCL3+qIllFFoZXRKNfqu904nQb5VQnkQESJ88I+SJYp46zRxLUKxA
FE3u7h0L6YuenPfqAdKeP4v9v7NCduLAkJC9ONEPF/nJThmJfkBdl1YbMh5/x2x31PQQmQfvBBb0
2DxDs4t/xAhZ6GGy2MTmC/Q6xkSznCO66G0xpOKNhYEW4+ia9OXyy8z6g9MfwryHeSJ3SUNvnrN2
moZAOtaU4z9fyBkgAfv5zHFAZ5tgTNW0EN1pOrrpmNuRHAQtFeoznGpMUMNa/8e0xPmW9Hf/iV/f
YpirEVtNK5hdCfzCbBcG7kGX90TLOTxvjCOHvQ2qNEqNSa8g4pB4G2NdUQqyQ4KDu63Q7OM7Obfr
h5xcOyNBQ0CsQCG8ux5lWhqCATzwyObRNwdpgZCX452d45yKpKg9EVlr2GNlFhCJxmZQ2bytFe+w
1NbtQkQlLsW76tzWcbYrdiqQuRVK1wlm31Mdi7sjaJSD7cXniOB9L/rvJzr1F3Us2raGTvtxlR+J
tc3gLdG+UeeTt0VImn9E/zJCdgynUPVcFDvY+vMekOXo6AgAvVEA5gWOVtSab1j7dXJ9opVmirEu
p0caPzqifZfY1ZGcAvXRWH7tjFe6F/b/sRmWpx3zmgqarIPHCULHu2fsc6Ap5sypw3yVP4JXhdf6
OMsZNTUOBjjipkrLQqLWuPe6XRY5cPOwsgs14ZfPry8ucf+8S/L97RgAEc8xKtAqxFE+kr0DXzMw
7P6RCyCzPompyGBEt+BviYxBXs6HQT+pJlLJYC/rt5qrLe1M9gqfG3/PajSRxAQkrZyrsQmlcIDa
S4YBKgxPCQvwFHCgaq7YpaEDVlKx6EUysary5x2Tk0PZRI2Ka6z6j/W79dC/no5oGwrj99t2P1dH
/CGJcRCGky4IpalBUri/894fm5cHy/39QRDpg8S+sHuicT3jmbuGmTdJlExLp8UV5oNFYlIdq9ga
H3Xkap4FUtnH3jZBpusenaddva79/85yfvLAa87fQw0M5ACyoagiGgl/Hmx6uRykXK1EALIXLR/p
emvyenE2v7AFhMvtd51oYkDlhzQG/uO6PBWXoRWvKdoKK8lww39Z3pm8xyTzHsBjU1x3Dr7+Om1M
DyN/tQ3+lSBEqHX7M8+FProMxWWwUEiGfjWDCbylnVa3ZZ+IqJ6Fa9k9qiiEw6sWITH4shZ0ERNH
IgUTRvcfEpmP3IiXdBiwuuOxuEdh2DDAt4p0MHqeLi9b+NXP/ETLjK/7QyJzOy+dkMVjlIm0FLlW
nOiRMp8h3cJdbjznSfyQRHF9cpplcRhB8pvDijrkZ+/G0ZE/XwK7DazHT7yDMiUYtNEtynul1JkH
Q5cl2UJ1GBRPMOGfgk+VrCDMK2BQGhm8DkY8rkCn42LVvUHwQmY2rY4iK4NJgaNvvproCngvXizf
zga7DwMsuwEltp081w/24W7ndLy04VzL+49fyHyELjn0J6zEwi9slyhMYFXFGvY2nvzGBVcgjsYm
trk6qESjuzbNdzAydry+9zn4/PEjmO9zzNX8kIg4JtBZawTDu6hJeCbJuO4WPe8/jHzyPZgHPMti
qzpZJbRF1N3t5NfDo/v0dXznhfdzla4fGjFPdz+OcO0SaNQuHSewGhCPo1obbdehRhSSYLCx9vK1
hakCeLQ+VjivsacEBiE8G3lgc6vGc0HPj9/DvO1yjpdY7+hndpx39XV81x3wsIDtsiEdRh5pziiM
LE4CZy7mm0plm16EcySfC4lKDdeXTbqVj6AFTJx7deHHqwFpAmzmStwLweIItO+dw8/YuYTtOw/a
ZoHm+6uz3S+ZESeDZeJnXFBERBbEPwWRN2DLqoXVaxwYpQ77DQtjGff6uCosvTiKeJ9x3aPM6R4C
JCa4g27zmDZRiokc5DZRT0J7FeQhLV4oRIqRFh9sAeMcGOiwoVxccneNXQ/rloIMpOUgYxKrroaC
Fbm4+bKyxyAm73deUhMNrTeboiCVAye19nfLwbc34Gyy2xR0WBRhaVCPkr1p5y//pHj1w9oYKKvP
1WglOu4c8HSP6hVmvLBbj/9ucUDkCvqT18TI8hgsEzj5aHuRanKIYmJGXwcnzryk+tVHJB4dISNY
p2EtL+obx8BmfNofWjIQVtWW2okRzh/JKNEWUk/9VFN0iY6Vx7s3nNdLZUAMA4dFKRn0Uzt0cagb
Y1p/RcO5Nkh8HmTS3/2HXSmKLlqmJGsG2/gktEJ77g2canHxLFL0Gz36JYaG4f6T85vIYc7PGKQI
pwc5z54TZQRZEhG9w9QuOYJmkWAiiDm9Xhl6Kzmf6OnRBz5ftt5rgtfgtpi57lq4h9/nxiA7MoaN
FkUQ09qN4102ShiB3HFFPhZ4WUoSNOtr5qJYc5Mls5b4LZkdtc1UM+66FpIHrEV7+R158WdGxsEu
AEDcNWyzl24ijAkEWh1cGJJF4U52z3aKdysCzGB50o5bzZ+JT6cnevVWJve7qLsE61Wgl0LWoYRG
ds19Pfm8BAbv9Bj81oxI09QaUoQ7eFevmIZGvwvaL+zb9jGX0vqhDYvX1gkMsNTedcN25N+RAz5t
tcaUcrsQnOCTtrqkd9stR+rskzv5XAwWm3J5LPqUnmFnF3fmqvXkfbNx6qcvwflMfO766rkSxA81
GRfyYB6kU21AIEgJJOe8bluy+2rfgVXctePSLC5OlGMg5HwuRfOgUVlYSvV2JN4iJgW43nbc/OAc
AeMPtRgQEccMQwgHiKqdxqNbTtOjjcFii+h27goPhzQc7dP2a3wKdqX/ZdDWIc4rQCXcwOWrfU1u
A7YMJZZF7YfGoZWtfzzzOtDmgvypktd/PxFhgoXjcGwgorWvG4ARbQsjRtu/AvBn2p88qpt51wl5
JxORtShJJnMlDrkmnHvMqjzqy1NN+nX1O18fnj6SYNnkzq69Q8wb0oIm5yTnWmJ1eSKXuRSD0WZS
3UBusgr3p0ckpJQlEhn2Dk2EnAs4k7L5IYq5DmI8nNKzAFE5KR6lDcr9u0/OFZ9F5Ik2zC3Io/hU
myZE1M76rnsxXIzK7YLC5+UL50PUiSDmDphHsdBa9QLP4BQgMXkg+ReqQpjboz2EsnsyifRwclsn
f3TdGjPonrDtEeaTJ15P89xVUCRdxPo0FJCQmsFVmdhpaiRipOkjTUbVua0cicNzgmbzPoosIxqT
8D8quxTrnOfxWWxMetu8h6hzIzT1nnz7a9ujCQUjwJxvOOd0TcUxR6toVXa5VBCXE+ftbSR3Ptin
C7J5CrgdQ7Mh6FQW46gIFwGP+Jmqhhh4vb979EB37UeBCoYTJM+5/tfs1/o+Sjb4LJD4NbXiP0ep
28MBzhAi7cfYH1xQrH5uE14u5RrbsVA50ZCNMwslGhEbGLjfKVHe83EpSG6KXe1LM1y6Psb7fpNV
RDZLQlmGdH25dZDK+9QfQIv2KwY7icP5unMgMP091AWZ2KtsnoSjRE9cPLinc+j7Dwn4ez9e7Qta
Ib/sRvb+0RCvPpXJuDXCRcm04owzCPf7BEli8rJZykG04bhPPNUYCDcV4XA6FhCD299KWG2VDttG
/hULtnjyLWN1+yR5tssy9huKHsfosMPNf4wJXYTmWpm98H2CFnCEeqWd/QaGH7k8PXOehiKjIUWS
aDJYZ06zQy0Se0MiBCsCmJXJHqRzmHasBjIcbZRmeAYz55NOxTGneujwOp3PEAcnqlsNmZ0F9jbC
GNvi9nnOX81vtZiHMDKqqjtTwzQedmhQxMTo7b8/+9JOFWGePzkqUhBuCVDEGWQ72Um+vl+q79h7
H8R33OGuWR97Ko55CuNG1jOTQg2W4haOU6vBxYtt9+K9HhfL5i3gjo/PMS3imn2fIAPch6w3MSIB
BVGoLh2s/8EOIkoZ6d/T3QE2rY73xHRboru8s50Lj6aiGRy/yHksm0UiPT5ffDzHWN6Y90TnmT7H
RNg29VNlnpWqxpE2u94BOQUaDDgQMhs5TxQxqKITeDye+/oyYs0LHBhKVQmCc5sOUz6YK5BHYDff
rx1WNX9yv91czX/67djudKVLL0NlxjhAp3UFfDlk7Xye2z5XPP4hhYGOcpS1U1fCQp6dtyIj2NMc
34vkSSTonYgduh2L597Sv/jn8/eXTf4fa1+2HDeyLPlFMMO+vGKthWCxikWK5AtMlFrY9x1ffz3r
zmmBKXTlTJ/pfpQZvTIR6RkZiwedJpz0qZIaA/vZN6ZgBvslJ7UayCAg5/qL8fE2UwYS5mYgryKj
soaW6kmWRq0nJReu/WzZ/ItA8lWP5ZOluyz5vq1qU3UNRZHJ0HXioBqZQK40mw/3MZomnf50mAWH
WWq2ycCrZVFMootZh/kZBWzjzU6dZidZNnTLGI+DTa9vBUKRhzpOo9j2ALH12uR/qLvn/BuDgMlN
8YctrCAokhjkasnSBp9nhC3sQufamrWl77UPwTp0KlP6Zdvaf+PRdFFXvNiMOr4R8mnSUdhVT1Vu
VXXlcIYd5cdpcYbRbFwjtSGsL1bo3JQSp+yf7i/75p7fWTZNKUWBmRkSgqbXY+ug1b0awCqkY7oP
zdfAQ4+DWXxeLkgm24mrQF5KvcZv6CHbH5x6r5Zmv4eXz6zJ2STs1d5QbqCaF1WvzIlwrXQzHXfL
YiHUNJu/1JxxrbNOikZxjlErOCocvkIh2pGBttJddN4dXg51ZTK194gF3dtqyldRsl7L4xlbTeIi
vr9PIHY2mN7Dw/vhwFRp3KrhW3MA3RgTc0uOUC7Q/Ck2MesyseS34BtLQm4zMiEpmoTYBLQtVJE+
mX3YSX1S4thY4aNk116wly7FbrrIZOhug0ct8mXIn0g/U1N9uW+82/fhCpw6s3EyqIFc1AK8GMgb
+yfVOsHbvXSIbTXOZJHs/M6WL//q2vgNS4tsVJlQd5iGJVyValfsHq0ptOQjyirIcJF/lQBebfAt
Y7m686dA6KRAwAajkMUf3NLE+C1jsBH/PzLFzzYtVJURZII+Hop2qP1UJIhPBHND7g1XdFQLD97L
DxPjxA7PvyCUev/rbV+Iv9HobYzFoOrzuRUQXCJJufAwfZIW1bSyUUfAwNq8QFZYlOdk5Ea1KBJW
5vtJaKujI4sooq3dl+7jOcVYGI91Y23HRVaIFIclTVAoS4PVSebgFqL1cIC8rTM5ooHkjf1zeb6/
QsankygiS5oqKBdpFK7u6BU72X3mH+8DMD8XRV9xni5cNgKh4ez5qYO+bIoJOvsjq2twm5NXO0e9
tYookaW+wM7ZCNPFDpLEaINEtTxbHJ2Q0x+MvEKi/KSuhXaB0k4CgklvNnmpXgXzWr+U1l5/8L5b
VnraPWfOM7xPVp3NNm+uoGm3qVfGVBw7LPL44X+417k2MUnRtLJdZPKkVv+8Y9EW6wxQVL2keRXI
HVaLfVUEi6/N+KU4ku7/57kzn5ND/1l+MoyG7OC9HaYYJRK0SKoMYPIeXugoTxud2Dcai/Ostjpk
FjuItumP/t5YOojWS2OhRQrM9BXiPZGFevnFq/ftp856Vt6O1J210cGzpPnPfiolVCmQ4XAJO78O
76hK8gvXuCiXvy5XTJXsX6YdF6FAqNyrI7JXrPctY5PpCg6x7ORmEogtQdWhOWVuAUm/t9tHJRKn
qOVgfFXGuaH1S7SwacoswQntULnvfnR7w2wRtj+O8DTcg/qJLB0DcfOltvqqFPlkTR8b0tSTkyqc
MOB6vpWgydelYb6yJdZ2UvwjtpHB6wuwaqdxyVCIt+JhtnRoM5cmmugEDyJu75PjfPNkSAqhtwYD
cZH6MWz7yNpoljGTn7q6/BVRVtUoxPEpHoiNfbaWempwYJkvRrKme7ZM0ZGAEvg8MLBmCNnLHmQT
obqWfKtwRxaO9d/aK0VEXSAIhaQBLMks/+h+1opVVZ7+aKMqNbHif6OwrUKa5j9ujUyRUEm0G1Ue
5nqEd4h3XWwaFm7IXYBo0307vbm7d/aRnpBZtbOslDG5UV7t8hCd2gRdX/v9qbBri1PMzrPgJB4z
K/KhuJn5P5lVsbcJG/d+AeXphHmQqGo/45p2/SOmvvin1vqMzfSwJ6LwTrY7VKbovr88M7vOGC6I
Qox5ZaxhPunFEIKGfBv1uO031gW2JbOy/o63f18BBIOA0a3CgO84uD5q1SS3csuX0XAMB5VTeLU9
j5+FZQ3eASWg3o/Bero85V6PitSXCBo+UOjwFo8/PQ4OJp5n1u51Gr2J8aDejKxiDKtKXkMo5Ker
guK207h65glTcTs0MGf7yW5TW4ldLjPHvfF6aDBu/XhmxZc2c9JrYOoIT0NkdEJ4A+bPilnEJho+
3nx+hvjCoX/nax+t9ayQ5KZXuEalznIdZoZQQ2zoisjg28nPL2loCTmq6WTG0dp0C9dI1CnO406F
UhJBMlDnLltFZw3Yy4PkCL72fv8cb9aBrsDoSiHoavdymQLsiBaksHbTj+ikXvPI7vdWqeHOqZ0d
RoLl9qPzKFmHwtnhYKuaybr3SIKWPs3r30GdZj7Cw7tsyKKbyOYu2Wxa1YGoGN1f7+ZLeo1DnV0h
LOopNxasF21kp1NtXTD1ytMsxzzgbiP92YnFSh1v8cUak3qy9F05RPWCtU299ekmSAagYPvA1Ehn
meitEGdFG7Wc/h8TPXbPkvcOycGzbrFuauKA3PtQlNOQJ0uo4mNhA42T76foxUbFbmSQstaf7Jwl
+Rz30Ci/IBnKWo0CoAWNie76w2HwvleHM8P6tty89QeiGMWIh67oQkG4iumeuyAfvURWwLE6vrca
hNQ1DEUhSm+IQ6ET23tFadIJpUn7i/n0zYG0EhSFjmxBata3ophkmYSkTTLyrY6dbSsQfnhBffWp
diMF9bfMqMqW77paH12EMY1Zhg5wwEFFyXCLI1okMG8GxRH3z/BmClFV0fWkKrIoKLTvISxKJEhQ
MLyWy04jYdzEWj7HyH45IIWfwPdgRnC2POU1IsVOnVByUSlI8BqPDYqIORQs4DGJSNj5zDES2pu2
uFocTVBVtPT9SIwEuygXloJNfL2/gZt8tIKg+KhRBw7TBkThyvVm7SvfoLjTWzEG3v6rm2wFROxz
RUjFwmdJPGAto2VnT6XVNCbpoz0yVdm2vPr196FIqQsjbQhifJ/jEJjwsg+PmO6cns7PRD2ImQna
tPPVsihS4iSuSyZOxl2l/ajeBQyEyAU75W0ET5i6iSzLo6gpioZO1m7mcHQ/TotZwxyQQYa8AfP1
wFoWRU81XxoQOMAmVjZUiha79LQX7gCaYCUIyWn5g9RX+0fREg+B6FLvFBIx9IercDmI9gu5ee9b
+WbkaWUUKlUTVlZxo8cFYBBQlr03/+PjtEcbBkadPjjISL5Yx8i7D8liJloBcki5YuBTWAYUIP0G
T1nRiRo3eTxWiYnH0H+5kSrFFaPe9JLBA+71jTPlPaoLULFxf0kMOqLLXCKtnjohAUSUmONfPKom
rEFkWcT2zYiMsUZ6qjXFoBgpnDFIJoXiL15UgYe7ce/u/3qKLQ8XI8SXLAwkZcfPNj3OFSZFTpjg
KHdRqOIUo/3rY3iYHzlI/LN8v5vT9aex/14aRU1TN4lR3RIYtG5C1m8xKxfDtRGrCixWcQ0hg3tY
FDHlzTjoOV4PV4jxC5fAPDAffdvm8Hs1FB3FYqMIUa0R6sPb5M2vHX+KIOor+fJbfqq8Xzu2F7NN
7r8xKV7CjKMG+vVYFcKNb41odpGpOdn3sDKfEa9m3I3bfPsbjOKmRezUqMuwQALmx/v7p2mzPl39
2+hUnuKkqR+TJJWwFs39RCn15bIvdiQajrq/EvPdLAbcpvu8gqP8lkqXx2BRAMfBm3gbneo5Ozav
0HKxGUBblK4hOUrEkWUUb1J2wY9Rkc2oxkAbrx28P+U2AvvoW2SgbN1QaxTKEiZ0EaR5DxSkEgwE
9WXTkRzMw2OsZrOmcI1DGUGS1aM018C5zZGB2Mh1j3pY9Pt+/45B6qxi0M3i1BUcfVGl4gIZ/hxw
0N6x3RD+xNU9aWaPGhZ/PqNYQTNPpJXBvLTv81OlmE/O/NBgaCpagneFf66/Qe/o/lZvBlnWv4my
nBwjoeuoJR90sv0rOuxNjINF0RAYGWKkP40HxrmTt7hrDUjdZcqkpRJy7CK8D9FLZ1P+gHeQ/0KG
YXT8kxn7l9LK3Ov+coGc/mQlr4jxKRYU2nMDhayO4DiF+Wghd8ZS6dtihPUPo+6mSpk4sSnxw14b
lIEYbL3BLX5bA1AX0Vz0ZT9VZKtdv7Uy3pS8/1U2FN5Zt9Fm+GONRd1GgzEVLU/OKYpW0TiICEhh
768QvOXffyTfVLPcV2i3f60DVgkaaxfJv6+eAnI3TspAbFzCzHnjMXPu2+tmNHK9MIqAxDyL2vn2
lY5vHxGGP1805wHWmmDSPDMssXULapphiAam0UE9gNpFrRP4eYLLcm36A/ScRLcjH01PH3SN4cRu
epRrKGrfBr7v5gItMdcjNAY/PgobqjaO4eU2OpcZ9MpaFbWFkB6OJqUAFO+9+p/yNXUZvLpZqrNe
DMXfi9Kh7TwDQvU8OOgsIIISDDvYviJ+fxqKug0i0K+FgLAJb2Bg6x4FOuwa2M3HxWopdFXbtFSy
lBgDsWfXnf1rdPrL/EEqnNCz+mve7RKP9Xn+gZL/XhpdwbZAA2jilx630pvvQnMRXOg9wUUmjXus
iMdmfme9PoqOA1Ef1EnA+iCMcS3PoRkesgjF9SZygR7GLVrPVW3+gvA590SqmX8ybHEzlrnGp1iX
dPkkiwj82UPFAkgRxap4BbDuXmIOtMe8hqG4V1M6LVg6mAv6Xloz9DuSL2HY5D+Q7u8PR9FFpkNt
IqmxFoRBMDXbTHuISiZm7tqV11mHX2ijO/+KMR2AcRa2vL/14ijuqOCrN30JXJgLOF5/H3b8Z/vJ
gmHtIcUb8/Qf6j3a+vnNMP3+e7eTO1SlJfhqUB72SPUMY21br7f12igqyYUpysQYa8PQAx/D/koz
+s5aGGv/KC5R1SCtKnJZlmb2JCMDcmtcY1nHtuPzt3XQcs1K06S9LsEEYeeKu/9MD+gaWB7g7hkW
jnd0eTxY/VE+ikf0SDB2kbFCWr5ZLRQOjA9KObrCMTwYVu3G7hFSiwyc7dv/9xopNkGqWOyFBTt5
RCZz6syRI0UUNmJZkND8zDtkw9nzGDc7MVY2Qgs5L8bE80aP1RHVNNQe3YQKMfsM7Rg/nryHdydy
bs0YLfOhwjgSdBsrXykzUtNkX6fFdvcoLYTqxjP3ROr7oVjNzMazviPFMOm4zFopYX9RmoH5sdIO
c9hbC1X+72RWQ+iisgszqO9/VNZ9REs9Z6JWIbqBRaI3GDKQuGuvf3mQzHlw0JLP2tJNNF3gdUWS
BbxoVZlyII0k54KULNFfXISIUG1g1vY3xTtghSi7NRmr29rSNd4fW9rpckYeQFDCOyB42JpXlIbb
s2Qq1iPvHiw0KhoohGHFcLa8MHQ/a6IiEedSEb6uU8yqaJgx0xlG6/YfGgrUK9ax37LONQR1GpWk
jgWpFWCdtn36HN1nBjlvOkdrAPryXoxQVDIAIOZFHhkoy8D7Gf1PDnpOMM+IgbfFoGs4yjS4cqg7
LsaW6Y05hKg1/4sBsFnjukagjKFXogntH0BA1hiZu08zJx4QRATvGx0Th7qxIUc2BP0AHLzs36Cc
GVlXTzvD9YF+AQOK/GTa81kvibq1o3jOEOa6LckGMWau4EE1D0eJFVHbfJqtkairum/qCHNlF0JO
qBYUWki0yx1h/sg8QNnXZqvdbzkHa0Tq4ta1oWwQVMHnqk35CoeOfaMxjikdsym7KkqVERA9KdCD
7whvHBHrb6iROP96vf+tGPZNZxWKqpYSLZ6wgbMTxa4usAdCb7Pd36xDZxJKLm/LPMA3UjqHb17T
xNMmM+KsJrZqAWqSWmaLdjVd7y+MQUR0cqFsZqMYySZCrSOBLNVhZ7GmOWzG8la2QN8bWYFuZJwr
EvF4e1MtGTKVoKIHJ74+Yioz09o3UxlrPIoq5D5N9YGQkf0mvPG/SrPZn1CpmnvyaC1oL9odSsF8
qSPz/PyTedRYn5HiD6Vd5GWcCbg9YnYTUWxk8caWK7deH80bUz1nIg9LQetEe2ktMlYtf3rcYZQs
qpwZls8iRJXijmEOZjGLiIW8+ROkGd2rbl88c/JefjLcmc3gxHphFGm0VYGptRJOGdTdpV37Q3n/
ed/aN/3RFQIdM1gGjEzAbGksxse9K+1iE83BzxfSeYKyBVTuec8jhq0eWZldBtXTgYNCmZZFSLCJ
sXdmFkOy6J3umRWkIa35Hn/91VZ+HKM94tXIRg5XWbGyDHJ3CPMws2r/4A3+zVd0O1uUBbrChbc7
BXExjDSBEOxn6LxDs+W7Y7V71s3MoGC6gVaC9PikJcSjaZ7ip2eWnjSLpegmtlTQmgyFOsTOS/gX
qZPvWtM349CUQlMeoBffp3ACWKeZuY8UYVRpOkmQhCAmiSnXyy6yyeDu7xg2vDujcue/PM70wCd+
mHJ1qXAC4N/4rmBfa8wbVjApfA+q+smiKsYdTc94CpRRqRPxdt4U1/+Ifobn9Cm9lntw1f+Hg0AR
SKWKYV5PBM6Gk/jmv/Lem+EmghWWZnBBQizG1Mn7lMI6fHTwQGuCBRKxNzZG5MU9XTz56jmHw61B
j6n0xrhe6HBBrcfSXGhY4YiimjffD5BmLp2dkThn1vwLhmugU2+UOu+6RZZu3y54Kh8QHmDldTYz
8ys6psMDg16i5IA8g6AWj8cyFNXfkdt6RrqAdbdsRlPXUNQLJc3rapYLHDPUdEGYDG9zhG9DDEF9
0h9M8+Edc1IwrQezeshgIJaUEItc6OFPqCaOQlHAQiEI4WZ2s/M8y0GFFF4wpLKC8Yi5KSffeVnQ
cYFBSQYlnQHXWwhUIzSOCdGTiRbLJ8/89lB8h9/1PH97zs4VUeZndpxtijisN5vyULJcUydNA35q
FqjAke0gNn/hEcBYJ8th0CnfBKozMcdJhDuRW8+dCLX2rPA000YpTplVTsOUJWKjeGIsO8l7QeWI
zbzEWa4JPc9JQKgzFmrgNO4bikfw7rxmyEQH9mXfmbJtIrlqOdYu5SxWMIJlLgYV8BigObqkEqDf
SB2O+7nHEDTcCtOOTJb1pnPgeqo5YWbKg/WIxgezPXIPP7PRZEZ8tlJHK7sxKMqBJl3aZMPNbhDP
GvZoQ9pfSZAJ+hXvjwp6kYi5Mgic8VSlK584SagMsQRotO9sOz40vw4Qrb8PwnDZDYp9Jl2VE4kc
CPvj2+7+n97M06w3jXruCJ0WpwEJ9bj+tD+FqEFDuVbgMGBYFGZQfsrAiUFrKIB59RWElE4THnE/
nh4g8oQKY5uxX6z4lUExSBcsTaORj3LEI8798MfLaX9B1yrnPXbW5EF5iWEGzPNHccmsp2pa3yJm
6M5t9ouNHDZqTsxq56DWeHAk6wUCA0STjPH9yOm6Q9YGRTCLzM8p3xDbGOzh2wIjH9lSmfdBNLrq
KVD/s7pj9oAb0L3idEMV4vL049vsWhb3zrxwNz0VNMKB53WEi+l4ht5OPWRoOJBKhwRma54uUGHy
8NCqTDKeGvpur6zy920bXWFSUc9+HosgSALxWuz5xXucH96hy+CUdnsi7tjzM/R9WJXc2+/jFSZ1
tONsnCSjB6Yd7f1qsBZT/ikcSqj9kmGDRCmTYS+bfLUCpM57MPbY9MUgLmAomyISzwHG8Fn3UTYf
rCsQ6rQnoQQNLREgssU/BUxZi83H3OrPU8dbK9Ui0VX8eaIuZacQoLlOn3PyQBQyX6zmhczUuL+g
TREcfQVJnW9pzLm4kwCJ3trM7Je3H5ZV+NoeGixWU7lnpjWy1kid69Tom0iMQwmT2n/ufr3+q4r7
1YLoWIa2zI3MxzC8I9yFFhNFS8t7F22EkHc2yxy23effu0cHMJo05DEAEqc5NUcLg25QtnRCvFVF
kfAT/JLv3wF7IHPOWKX+rDNNBzciLmolTgDy8Q11cKSuaP9kPujme4gmS5Yw2PZrfLVOikHQi9dO
Co+PBhVaiH5iFjKG8D2pV69DOxwGmYafzK3dpOYVJEUgTSNB8I9XscAjmvpPw3Nmt15ki4kp4MUK
fZKUJBBtlLP8qytvhUwxSaOXUoY8nwiVoFffj578dOfC5US9ju09aN6DJVgiZpjuWGEBxsnQKHIJ
01Qt0xxH8fNKAnCdf/+oMz8ixS5y3DVZQa4eH6WTrgtZBO/JJKkvjDFkeSrb7tdqEyle0fQ8DosR
FnP8aM+GVT5hUilLk+AfDgG8RKi5GTJ/q1Fb1e4tcSIkkpBKWNEH3o8LjHL/hLv0kGDm0RmzGVmu
+PazR/6NSH0joYV6x0wQj9n+Y9ijDQqO1+CT7BQrDLDt7K2wqO/VxD10BzpgoU3E/kBMyr2AWX5A
QDRz0Dx+/slwuTaVyNDn8Pd2Ut8skIUirNUE1Gx/9hf09OS9HUKDrZ4wgmVvinvzwZyc7/HbYfeM
tP2vyMzO5OmxW55SE3cU4x1L4P7wAFc/h7opjLGShbTF+u10N49mvs+fbVY05x/s9O813w7NyoS6
ughQUow1l+mu+qY0rrlDe+oraiHunz7GYm6mvMLBOG2tW0osRvnE4D8yOkJh8NZme/bq893saQVR
yU2Yh3kkId59UhPSyXuwR3MHETuGoWwHMn5/mVuqaYWUZ0W0VAU2DTUH+B/1+3hjCaNts7yTbW/5
99eRv9YcDJgYn0QVgI7cc/Qc9NC23oXP55g3WRMc/uEq/w1FsX41ZWIaJ8T4/Vth+2xhWQiJ8c5H
/pIdwyuiQiP6IbJHlK4kLG4mC7lj6yLFK2Ov5wHfxuTovbkf7h6iNeQlaaK0/0Ck94g0K8tetp3Z
3yum+GXQwnbRCGZvvaqHFnVkB7gr3NPxJ7NV5h/unt9YFLWUc18naQXbPJJyYZdDbereg/Segwck
ZiAwlsY6bBRzjPVYz4kBNDsKTOHcve5+sRwwFnHQ2mmKoPdiCHWA65HU4aCmF3MGq2MGuRaZxR1M
LCoSpZT8Mk0COdm+q1pNgnHAoctdWW8o1n16myy/OtdzF6iVevtKGByvev7Hp3lFH/j7+2hDi4v1
lZjLorxKYy7ySE2J0Qtw8XS8DVG7RIoi7lPvpiDLihhvgb7Vsnojygr+dpG8+dX+45Mz8caHQ4du
LQ+dI0jNQZ2ksojiFyvmvOnTKTomYPIKD31GaomKBD6W5FLCA6F1FpSUMK4VYsl/8Mbq71MEqUqT
lLdzBsfcwAsEmiOdyf+cWX1H2xHlFQxFjjI4OFDIMl7hDGs+AuV4XN//SpsNBfoKg6LAQY+DNjWw
FIwscUnuFIV7w1GPMaMh8SOvspk9g5sEuEKkCHBKwwBz7gvycUSvs5GnMlIEdG/NqqybjHyIex+K
IsC47zADzMglxLEbm3yp6aHJMAl1Bxka1k6SnbqHRdGfvoT5KMvYyR44thvZKlKneKax7kyG8d2s
ZnWuRMzfWGRMN74mld1en1GyyhpdyzK8myeyglCqQhurHBCvSKXXL4OZzVatu0w2Z3yeG1WtcMS0
HvUkBM7sHd9U7yM/cJNZoHikZm3atvP02+pubtwKytCbvAwUfB0IYWI2qwOvYjRJkTEz7rcZElsh
kUWvkLKAq/NeB1LtvNmnm075rcvcgYdrHV9ZWdjt62OFR7HE0gaLMFTYROk2DNpHi8tFs546zAd5
R/cCBvixgn6b/uEKkeKMtF6mDoOApGv8qnJovkPh1Nm45t9S89/djSsoiizKDNMcWgmbmRKPV8N0
NlSOooUHWRi0HpJx5Qw+3HRiVoAUY9RlEM+cCkDeUz+O/slFwmt5bH9gmO//RY3AnzupQ7BElA0M
qhFFmX4HDYERKOg7hzuTp7vF1Uz5HNX2IB663Na/MZb2J3F8BaP8mbEZ5EFIa5xqyKNPNgI7mIth
nJEzwX+MG3IjEv0VjKx8dQoMbqhzzDMDGJEPXB6ayIzsPSqb2p6khFhwf5LvVzjqxq9buRmWEXBt
89DZsyUeajL82tb8h9hCGeNE5vPY9zeUhUkd9FAu5jSJG+lqCA954ZSyYI78c20wYJhbSR3wqIjz
bILYGEoI8TIaDczUa2cX2luY77hwTLf3T/76upXU6RYSzhDGHstCjR2vmsV3HoWDu/tbxzJF6lgX
zRCHY9GDI0fbhVqp/MRjKKJl3UfZiBt9XQp1mOcG0xtkDUtBJzVvpfhGIfo95pPcW70Ah4NlhcTK
vroAX/EoF0DTk07lWuDZ0slvrilnLj7iYUyWYlge/QqaF4ggNeLtE+V/NS8sg/uTA78sg5beruBi
LGqNr4O+azQX8jjA8Jx+QFZPdvLoojHwyMe+s2v0+4dDn9BSkV3zX+PvkTs+FSxSZ3yXm6LtioyG
MG2FqseC0D5/TK7yaKucm71WCCywFOU2HOqvm0exAqfEWr7owHr1bQ41e8F+QHPfbXIcY9823LSv
UBQxaBHUKfQAG8cZJkbU9U8RcFjRoI345FcUig+ivJS7UgfKq//Wv37MjmEu1aG3G5U8HJ8dSzXf
MYXlkXs/+kfu5B9tqz4RjZad/S88j6+/heINNS5HVL4Tw49Vs/f+SvdSZkKRkJWN2IjqfQWimCPl
M71fZlzMZOa7PSZ7zTI0q1BNm1nxwuDC24DylXH2QhK2XTggRmke7Wow9Yf5R8rqwWFdIjJh/RXK
0gqyNI7ELNHaauuegXmYp6vpeYmKUuNXBvH++cb7sn20RHTRBFHK8/hOb1PoKGbzAO3KEPVdjnIe
Ip+d9yCH6g6F0ErQrYgGj6jEHqKSOqoPD8imapYtPBlor2Ocuo0Ewde1Ua4GX4stn5GdxKUSfKDW
C1LQUJK6eJg3s39AbRDztmTdYzLFKVofdGE9Ynk26Pjkm7k/7i2m68vgYXp0WtjWetAtQMFklkM+
mwh6dblpci+KB6ZEooFFywxPQ6aYpZ1nIxskWMlyetXPNVJVPTMUtPHw+/q5KMpoorILxrElDv2b
vSDiNUFTyk8j577JszaPIoylEMNuNAhLQi7yWDD+OovqaSnnvIoafhiwivy1VE39EFdWq+8xTrx0
jXdjd38tLDRaUbHA5HhDaW57Ntj8q+GKP3vRFHcteyAb4+TS/Y0YxqYZkgQoMrgc6TaX91u3fsdN
xgoKbvTdf7EEWqe5n5tYwdgD6aqiZuBNbaBYZZgnZLlacx8e+OemcCavxvGFahXDM2SRBi3hXBdq
K80V7hMJaQ4fQ0ZQzxXjRZT7GuQ7elT0i+aL1UMCrPAZZMy4XxSKPMQi7dOcXGVZ58iLdeWsTLeV
hfUaYpGUQnkjQgCXtG+AQyQalsjG8ytzEbOEi8VYkUCI4Q7dKxRxCO0y5xJmmKFi59U30BN7UR6X
DwTbQqTemAE3ljNAq1mJw4TXLHmAoSjCrz5185mgMLPcrFVRFKJrcp7zCmBG6/VNO7m26Iy9g2TU
4ji7TmE9jsifu7eJ1GOlEcs5VcmT+VUR4N8fl8rkPUhSTBiW1uwsqDXsdhpzuCyLj+lOyTCT82EW
yWZGg1kFFgRSUvsXOjAY9/Q2IUM7UBKhP8bTRYZpOSXNmM5wjnsiosSd5dZinOp/WMtvDCqiMhhC
P0fdSMjrOH1zEOIw2R122+f3NwgVSan1vJmWACBvpAq0tfa5haKjR1QcHQqMcGZx/7br9huOcm+0
dJT4doYXcPQxMdK3WpvMimZtHQuFIiVVLSR1gaza9bXizQAz1+7fYLRtYz6EhI55XoA6AK/KPMVF
CMyEQZyUylmVXSX4LtmYNtvvxv6QdO59JPrQ/i+SAY07SdFFgy5Xr3VBCniuU84Zh/ir+DH1qM8I
Wis1GN4Sbc83IINMqOJJVksiP2TlwKvGOKnyEihnrsucjv+rk75rzaXrR3ccGbu3BSUZkq7rkoTb
l+6RNVpB0lI1V8+CmfpoUp0slRnUon0/spw1BvWFOl1LMiEt1LM+zG4y1i+h2ppG81dZYBpgBzvn
Jq8Ng6ckZvHs1heTyZReXeRR5U4TQ19MY1gai3rOoXdiLpJmi2NgKZ1x0oX4133r+ONSJMtcg1EM
0YVxsxTJrJ5VMShjj4+hAenkSlY9aINg/BCWUd3FUqw+GelwGPKl8rm2Tz/mgdPdSMA0FjOAjYdW
m4rGt/u/bXMfZEhma5hhjil21E9LolEYJz1Tz0Fd/pi7DzHszSLMP/Igdu4j/cGTt11QMWtE0wUZ
EyLIT1nZbhLUNaL4nXouZ87UFpsT7KDQdl3HWYuAKc212ZftX92Uu6Lw/T427V8SaEWQBVmTRVGE
lOZXaDkuZrWKA/U8po6XjYyVbe3h+q9T3KwECieoGf56GJrz7KVWtnjZy/0VkJOwvqdvKxAFXsBJ
NAye7orv9KWddShan/XyMYxwGsWDrn3cx9jaJfR9afjzhC1pDydTsg7J+lI7B/mxxFp6Vhnk1kap
giaKUGDWVPlWB7SyAMzRDTWhrrVzEznKYM3hrhL8uGfMatvaKlLiD3tWDIi2kn9focxqUKbtPKnn
RvWgjFA/j/r5/kb98TQiX2MNQZnyLBS5Pg2A4LnQ0/R6nxmxE+iclSaOWIdWM/H7uBmtpBIO96G3
tlDTcE41mddwiCh/bcygTCYT3ioDp0kMW2g1s5MPYj8wPKety3MFdNuC1S7iTc6lQy+Cs6LWLAZL
UB44QTclDnLtuWAa0r/5ajqU+yVMT5ehovj1q/VSM+toe1LPVaWYvFG6oR6YaVMwHN5N4/gNQwfN
hQ5jApMFMFGj6ae8FcbdNE4/2jj17n+orcOkGcghaiKua4l2CbhoDGsJosHnTkO6oUusscnc+xBb
tqDzqsgrgqFLKk/xzrxI0wwVZHACV1niiHZV8ZyjSLsrOPP/GQnmhiOrYZ6BbBjEWFbGMFdTxPEd
p541/hU1AebSHAN0hhcZA2fD5/iCQxlB0E1LnydYUdbsNf2iJ5GJsbG2Jp5njVXju2EJv7GUP54G
xtgHY0EMju8kU8SMOj2xdJnhSG98IpknilEYTKGIuk4taJmjweATXA0gCtkupaKCpsnSWEKDeEMj
ajVjAzesTuYNAebGi3BtZOpDYQaSHuhirp3r7kcpqFYhPN+3hM1dWwFQC0rCZeEDGQCx8J5mj62E
8aHh/j7G5qYZsi6SB5sq063Jad6FbYWe8rPS7QXlV7U8xNUZ9UkMhiM/lbpSsVe/YcjPWBm1PEgC
1/RYSqbGgaM0ZeoZeT6gP1iILQS/vkOCV9nXamk8R1nFoLstb0iWSB8aHig8L9MvYDRoRcFSTPpZ
SVpLHOZdMZjy8jKkiqlLzS6KnsX8e69cBplVTvFH7R9ury/QlDck1ly9xBqgJWAKUndomsUTotTW
wFI/CjmzwmByQkneFUZ2aoOMUXG7vXZRUKFdgRmjKs2NYwrdkXpI9XOXl24/hYc5iw4aXzjd/DDK
wVFUo2NSYTxCopeXMn27b15bZwSXDLxQZDt46Kl9/e51JqeQgpr1szi00LhC7bEV8zzL3SUnjbYu
ScasRHhTsqLRztSylFmZ141+hmdoTs17UmbuKF+SpLTG2B37X/cXtfXGkCUFo9fgI6KIhE4gKYma
clPA62chtKfpOdXtsnQCblfxwc4IObtTG3vRr9wwvVS12RiRPRgp43Ldom885zRF1USZ7O3Xna3a
Htba5cbZDzs34HdDY+mcnWWMg7sFo0iCYABHM+AxfIVJFThn4ZyoZ25UndEYdiGeU33oVKq6D0UG
2BYZKRr8EQOIKtpGv4Jpfa2m7Sir52yqRlcvhN7LWknZ52KluqKes67ALYJFDEGTcF3Agb0lYles
NM9cyKEuFw9TI4arpVSS+T+kfWmPnDoT7i9CArP6K9Dd0z2TmWmSTJYvKCs2i9kx8Ovvw0j3nm43
apT3nugkkUZKYbv2eqpKN6whKFOy4e6vnsyDP24QJHqQTbg+mTfkpU0HnGwauoeudUXQSIyhqpMn
xp0NO3gDQl90jn1BTNE5drck3eHRnkeDY3uRnHLnobJLD9C7Ji7DWZ8Hf6itNjQTXu6MsdjZJC39
ZXxlGWMLgpjLaS9NRgIZu8ar11b1bsxr84SoSDxoU5o+mbzdcLbXNMVyNdayyZA6asMw4yUQFoXj
nOty+qyb5Ijb2rAD6yTgWFHDg6Og1iwzVosJ2GXnzHPnT2XU3yd9ajacgjV5cXQTEbBBgMVWZ5oQ
AB/GrrNx97YM8tg4eH3/OHpxkBjNoSNsIyG6xleO7ixBik5MhHvXfDXlGabPYEr6eS6k8cE288JP
JioPFmHTz3wch41obJWegcGYFDyM4a2KOqD91DoDhXPKTMe3p3nPW8xuKT+0VOzvK9m1x4K86BTb
4U24dAoTF5pJbVkubvDg8v1EIZaOU88bz7V6Hjj1po7g1blZm1G19lQ61eJiCXnISHnsBhIAG+OL
nG54WqsHuiCluIuezbkxOpmLdKIcQh7zzvcKZ9g40JpKgzNquh5ml7q2GkoSrPsiCePumcYV8TWn
a33mzsPeo/FWSLRFSnkhKXPAfNzFqS+dgywcz+/5jEnN47zhB6+lACzHo8TWkVSyYIuuuTyuujHD
CA0EX+I1Hf5qbhc6+SEf99wFSrXMdpS/JnF4nwFXWYPCs3cs+K2mGr1OBq1TmoKoXZWnorde0TD7
ajHr0Xba6D6pVdaAN7EAUqH91EE2rI7lNOTI1ehW/myyfl/oW6DltdMgOobza3hQrrZiWrs8cRpa
jO4Zo1qPKJvv0zh5q5j+ZNn6z/unWVOBF6RUbzuXHvDKHkhlVnuynT/c/EL6ek+n2U+LDVprx/IW
HUFtGzpQBdnATxiQpPHcsyx3if7YFwEddrl2uH+iLSoKp8+GLlOkdN2zQfxqjqoxRP66Kvf/ToVC
mVOg/SC5KjgDZzQqo4DGI33xxPmJJFjVMWKbs+5tKImV89gG8nUuguQl6lt+fuH3JN7sacYSD1XV
jGWyJf1qVHzndUXhe7TeCv5X+AEeJPKDyOKBA9VsU0wTjHVsGD2PLT+ImcIDwWsGk1YGY9b/Kcw4
3/CAVuTJtpbFyHAmHKxDUqyUsC2r7seSnm0n/1PzggfFqNHg/nOthLQAfcIfxImoR9VZbG3R2IWU
HT03fUByTBkFZ8Rofqr96ntZ7e4TW9G1Nv4zDNvDOCb4LtcvVhjwKjze07ORLlXjlCR+6/BPlWVv
sPraYyGRZiGuMOCFqfYjpliUy8yGnlPjTytOtNH2DojlJQlc88v/cCiKcs0SxOB3hQ3hklcTxQja
c9JHvYiE8SHbyk+vcTritP9HYjnuBadnKeMYcTDg3qgVoFCyT5jw9USEXLINoVq7OQRDS/yCvCpc
7GtSZOTF0o9Jz4P7c0jNE1a9oktyrn7ASdwgtcZ6GExuwuNDGclUU4R5Uzp0QDXrPHCfuwGrMb70
5GGq/0dUlO6/0Vr+wL6kpRiOKfOaZGp03GAeFKf5p9H5NOJHPvg7Ldt54wa9tQf7j5yl1gplMpWl
ZoCcy5+a9pHUT+MXR/99/1Dr9+fBkdAxxx6e8/VTGY6ntd5k0bOU31v+ZlifCxpK9EnQ5IVYWThm
G5HHKm/Y/xFUFNKAQZheQmZ6rqzE95x8pxtfs/m11J+Gut1QfmuqAluOERToFgyJ2neFYSLGhDIZ
RSX+3MpPQ/kq625D9629ElzzRWh1k6KCcH2BszNObTHk8XkgMjDE2S6B8bP+EvLj/kOtncUloOLB
WpGb8pLgWABgtGD0mHVZWNK+imijFx8EEYf7lFZPZLseQg2Uy1Avuz5R0qH8MVsx+M58w0JPv+QR
civsf6i8LAoCNQTE3ygwKp5EBWC3pHoTn5s4zOwA28wK99P9k9yMJEX4DxoUoAVETkAvqLai6Cwj
1/X4TGw73eN226NndG3QWCINupqJJyNPvxDiNTvk0uZAulI7idIVh74wtJd0MtB2MLP5gJ5efYfp
ws5hNvXpA2HN6He2sTUecwl8lOzdO5ADySzPg+5UAqPacqexc2l87mb9Q9wkr0J7EvHHfBgONkpT
E/12/4LWhHEBjvxfeopGi1OWlEOpxWc57mi7i1GmbhNsswzvk1mLWi7Ppfqmuob7Muw4PjOb/Kax
4fpuWoQNMieAtvg8AwasjPdpm/mNtZUXWBMcqpOluIfs643geHOeTZnp0TOXPwjYWet+etVWrmNN
Zqi+kEFMgayKwmiuzD2Td2l8LiY3fxg0mR0wMuZbV2O7AApY1YZpWHk3B5E64GXoMHeQ1LgWUUMS
GncYPH227YjwvzUwnJBSB+17It3df7sVA4FobMFogB0NqnYJ0mq2eVLl2jnT+tAq0wMrpsDAitqh
8TGWwMriYC63rPrKmyHn6bighzgQpv36fLHw8imv3EUOJt/MfKYl/hZTrtEgNq4RBXv4DWq9vm60
MdUmSzunkhwGp/BjQfY027i+WyruonjgU+l4MPj81ydJjNoeR7TSnwnkK2GWb9LBJ9ZGTnW5j2u9
cU3lRpfGBgWSJz47QgaxVYZs2DjHLYMvFFD2takNhaHGSbE+8m7AUMFz3j1I82uMFfda96EYXu9z
2/p1/UdmYfwLJ7WXehGbvIQcCa155NSaT0YsHkpB/7Xxi1jXB1JULR9bi/czDuQK325DFtoHehjH
Dc13K6ioNKEMi3yN6RLI6vV5Ct7CARkIPXvyRxF7ga7vXSCq0jb1M3PD21nxT+EAu6BlLFAnJIeu
iTXm2BVGVYELun3Rv+jTENjW0ySLQMv3Tvaak0+JRO8ZLTcS1it2dqHsOJ7roqMYKdhryohcqray
cZll+9NIPzemL1wsly72lXMgZjSzfVsDYce9l/hVNHtd22nY2Ty+6Cz7asXep6bQNy7+Vm3hi3AZ
umkDpICy0PUXsXiwTY4c/7lJv4th9LkTDOUJxmf8THqG1Vf3+Xb55xQBRFFX113sDDeQEFa8WiQX
mw4ednxOcijFZtBYmJaVteFrrkjH4qajkwBYJqyfWn5+IR1S05MZ7SS45gnqKtvBJfTr8e3+UVZu
ziZI26P+YNjwy5SbKzFEV2oaFP5cj3uKJbDDG2P7xRGspnCafhXu7/sEV7wD1ybIb7soD+soXirH
MkxpdaJrtLNbtmOzqzXDyH2N6CTzvbkbfzpDkxLfIkbxSUNhqge2n7POb9uO/juQYWFg6sKEY7wc
VZel2e1Qax420Z2NwkZxvq5/jNbAN57xBtMP3WPbi0FAaIy66U1kNw0jnUoTB/Zyn5DiaLkitOEJ
mZMX0G6fi13bffDM7EUyVKo1nw7/Dh7EJyxIXgDKiH0TGtnCdRIUdrWzJKe0+RL3Bw/7U8bD/add
Y9hLKgovVc2U2TF1tbNWfW29V0zsR9Jwg8atz4yTLJkgOCioWKlC0WtdYzRJlkRInfD8cHDl57QM
p4+ls6HlVkwgSrxAkqIC4yEJr7DpjHGzcjaKJEqTA8DDYVZ9oHMa9Nm3f7+0SzqKzXBbp287J08i
lgL4NtWnuml2XrVhLVYs09VpFJXN57pNbAfXlqYziiOncniIbXTcMzcYtp5oleFdQiHcFkDPjq7w
QT3WVW94bRLN5bfc3OVWmBreA6aZvtrWkVV5mDavdl7747kl9bEf6y383U3XziJyl1+gPJ5TsKRa
Wl2jNzTvAolg+o4Mi3P/yF2fZUHFkToKmjh4Cop6g2/WbhpWeckPYNgRfMFrrV0TLF2NhyGJrMyP
p13aHjo9gMCN04YkrEmbazkIdZAWReirBO4YSmt4mmMmUd68VNXO6w9MbvDmmgxcklDsnNRsUsaz
lURLElEzG98xn92cHWpnA6yzZoU8A/BC2HDAlVRfhhbCcxlvWNS9TvzU8j9j89hVdcCTH33zEut8
g96qEbogqMY5YsYslEbvWCQcxx/mP7WW7sRywJgFs/5UGswnPKrytN2I5db0l4cUs4NUPBLoKnss
dVe3n0E4w/DlzLPhJn2RKCNPFmp6H7w+3aC39oSX9BQuKbsCdtNtWUR7w2+n85zFfqyF01Yjx03X
9yJycImQRYJVx19UvreJObZCsohkD/b0pWofmfNLethC5j4BcgZXuEw+kNZHvtuYv4/iY6vt62I4
8Pp/kIvLD1FO7HKmo4GFsKgZHvPke0ve2LjBPmuiR3ULC9iBVwXSXFEvOU3HmRGTRRX4pItJoGel
3w1b1ao1XkFNzPOQzIC7pGLIsOAUi76dhEcdC43y+1jVb0bxkEad2/3IvE/37dAao1wSU2TdY1aT
yc5jcN89uJnWY2a8ssYnbbf7/yOkWocC696x+YlFnGdhNf0xchFYrYHECdmgpN6fA+wWugDQZYCE
D8VzXatit4M0m3Eqz7XY0VTft0ZY1XvAFkM272i8YWLfRfcyKlDJKTa2N6x05lMmzxYsHup8RIQG
+zm7vxInIo4RetPvie9tvoGEUQ0OMEOm7iFMMBcEIL1puq1sbtuxqZ/npt7nmpX6liejZtSKoGyz
Y8f1v/cfcI0goi3kiJZqLVqrrq+1MJpmcLLCAHKW+mg3fsj1N7eDtbN5gGE7GwpsjRqCLSTZUK9C
S4fyiESWLpr3KuM8ZlwEduv+jIW+jxvvaz9MZ55YW0GBaotciDWhmIiPeABQGxUw4BVV2VZogTjP
eha4g/0kzPlN18oT8tpBkvevZh3vutrbyIUsbH/JPQpZFTwwcTdxpgxk4Vj8pXBSqN6+3X+4LRKK
ik4x/wBhJkP+NyOnIu/2KHhuiNyi+a5P4SLCQTLbhhgR990xu4hZmyphVe/yJKJJsZ9deoC5eODN
l/sHuX2iayoLz1xQsRzKB0yFSyJ9zH00EwXCpEFhfMzz7MiQk+joBxQiP94nunW0RdtcEM15EZOh
A1Gz7wKZAAla7mhtbEjzws43FwgMKAUMFNA2NYM4ZdZcjTaoWKL1zaYO3FYG6CbN0y1Y1hYlhRti
TGfVskkkUaedkF0Y9d1YHrKtsvrqrRnwQExwBJLXSkZU2qIfseAyiezZDAU910MdbtrjG3cOqBsk
Khd0D8QWmX+FSq1VumeN8IXl6AJWn2AxhDscyvy13QvM30hdNJqjey7soJ3vc8WtTIEymBhuK7Jh
nlrrELmwWtFTvBcjmA4gUhaOqeXu71NZuUVkKeA1wtewLRC65j1HWEkbw5pFlIjjCPR+ZyTHzHm5
T2WFI66oLD+/4PBEYyRjAEJEhuftmPhcOSfWVXutfrpP5yZAXJ4L8TsCRKSekHZSjjOamPhtFXBs
zPhH1hd7j2FMhDhX49+6eS7a771u+JN9lCPaMoYDACe7+x+g2pR3+kgIA8WCS0Wb2/VBAaYHEDYR
HFbSCJnNQzF+nj4Cob/lfa+929IBsFhmDxAJRcawltFrKbahRGk8H8TgftAH7cG1NkzH2ruhEdFD
cQPYH8Se18cZgR30cjbyyLC5r8VuQOKXVgf+udqIbVcJeTqCF7LgfHVFBXaOaNzem3hke4c2d47Q
GUyvAneMN3Jma1LlLdOU0WGJBLPq04xJnWRi0HkUm+x7nBSZb+hJFt7nghuHDSl6HeA5sCJuD1yo
vI6VN0ITosqiov9cTOfercLZ6I65tfeycg/4RzDXqY8QZqsp6L2ida3lFxw2fjk6QDOQ6OsXI/2k
e4lpppHmTr6dCH/2DhiASJuXUZsfapcf3Cro+aPltnu9q8Mm/9qk1sb5by8ZAEJ0p2BuBfQmwJHX
H9HwOK40HmdReRZRs9+43FteQUfakp1ALf6dLa//dWHJSkvdJI+SAr0MR1oeszga+/6JD9kD1XcZ
8Hf82c2qg8cOVIwvlD2UFTlD42ww060QohUT1WBE3Xhk631D0oVaayxuG+h9KqIp/2VWv4GTrOWG
RlsjAU4CzA8oUxv10+vDcoK5uBQY9Kj5Wvcvxod/RqeBVcklgeUDLs7AWG6XpCmLKLZtX6sfsUxs
gsP9IUWi/v7DrR6FQmcBeQLwr7rfeErjruhlXUSyH48yfnBK8Zxb2vE+lRXuWK4K7jxwJwA3Kwa7
mbum7S2jiNjknCzUN0j+U4/r12L6fZ/QimvgLY4BhrOjxuFiQML1zbm80pMpJniaHLtPa6zA+tqJ
1B+yU9m3gTGlgWPBiYy3UHE3OcjlyS4JK3mIOXG8SUtB2KkiJmt/KD9z61SN1iEvqiAbtLDCH1nQ
zqEJw9NPf+G6OkgX0uj+Fahh8PuHoM4C2M2SFlVHUjZJAxD37BRRPfR+kiZ+Ij+V8uhA9Vjuhwm1
8P+B3rv/D3AyIL3KwV2Wey6SIpA3Y/psVZ3V+HklGqRaR+coTSMNZkPk+7S0ho0Q/NauL+2cUOgo
L8HFUOHkeTloY9KlImJWf3JyRAKYKqSH3LO+jNq4QWxNiZMl4Dbg/KG08r6V4EIm69xu6iaZBSSl
gLMC2MmLlVY87Ks4TDVZBUXHu71dWF2ITjjtUHpu/hTXsjkaZcEekm7KQm8U+Qbkbu25UZyFXEFj
6ESdrSfR+CimuoJKp+LJiu3PhZNjdmV8nKr4uRYvTQr44v0XX+V1Fz2WGEqD8A8V6Wshs42WjT13
ROQaz+NXJg+DCfU+1gcUfuvkMNTML4dXxz0Ro/UXkEz2lp8qsmFzVgwaynhoPgK+AxMmVPRzWQOX
k8SijJoEDW2zWXs7Y0inDXOyprqoYzvIVSOz5KgKpTOsgiB2KiPvgHLQW+6G+sYLrqngSwqKAJn2
1JBZBwUGF4ST32w+WxskblZmQCkgcYS+HzR6AC1uL1x0wbyt7IhEekdEs059VGcs7Wu8I/KXdfCm
zhdVaMUPhOm+FLvGOeX5j+Fxko9xF7Di71R+Fc8YzzCPO9kdMCY1sMm+11Fluc9WK/eAKzYgYEhx
AWil3EOn9akYDXTnOul0mLr2d2UZjc+arTzrTa8yLgPVaPSzomjkWYa5fMjFZcyF3RvCGgRCe6vw
3coLeaoHQITvevuk/6z4W4XqeGUHWRxqm+CFFYa6or78/II6FfMsBUNeXHcxafF5ls+accr4j//h
MpdoB4vtlqZ9JWvHHZpNADhCLcQaAp3M7+osTNlWxPOeVFVcW6SqlyAcAyPQmKzYW13QWNMYVEEy
P7QV1g0lLwNy/y1G+QJuJdMPTXVIZ4kItgyoFwm+BwbRGDE6PSt87p3Sz5y/JOO+GwOj6v2cjgfh
PRlxc9LkRjizoi8QGSE7jHE38BBdRQZ4JzF7irgiykuMgbI99ET2VbYFClp7XmDBMJCIQuJcFWRQ
0XEeB8cSUS1/JKN+4PGxK2efeX/vP/BtUgw1cUxrsdDltKyjUdhIN/LMy7q8jGr3IwXglbd/vTgL
JgDR6E+Zn2XsbMjnirm9oqho/XTs8pSh9BF5giERHNapCKvsL6mLcND4BrFVIcVYJ6C7AbwGEFJh
YGxHKszZkmU0TUFaSjzVW+m+0rYNm6YLEu68Zf2xGSzkLKxzzTdyI2vBIjyKZSgS7AvA86qOyIG4
QxoGvlxZ+UKOvs7Zh9gb9rWrvcpq+i4w8d3qh0/F2Prx3M4bZmeNWSFVyIIvY4HQwXStJdjE44EB
JhkJPdb2LfbafZlaTd9IJaxQ8YCeBkgb8RKMqSK91GF5mtdZFY116+6kN4/HIm2Mh39mVWRF4Dwh
sl+a2JS7bDWnpu5gVVFvfc2TZy60Q6wbDwY39rRyA1cCCTF8v09z7WQIdpcWUURp6P26vr+mLp2m
N8o6KrLOCxyjNINhsNjGK62IBAiAOzApB8k6dWFlPjORaFpbRxiQ8knPdzwZHtxEBtz5s4k0WDGP
V7QUga+s1KtLZAcie0L5cbYeWTudbCo3OP9Wr4DpdaTMgCBCokAFNdqi0HlbiybSrX3fj+aDRWpr
34zpKU2rZ8Kb712nk73rsa3WzYWlr00JKHtwVOBqAdevQnByCMJkGBg9OBWnMkWIRJ+RCdLSLDRp
pMdbHT+397mQAwJhabhF7l3lkIEAeeY6TVQ4YTs8auUzQDMbWmzlMvHFAK8hIYFqljqwowFtg+ai
iwxZPwIA9+K13zP+iAGSe5T4vpd8Z266N7ecj+2pCP7gmCMiRVfgNefLRpLabdMOV1bZ+0mmJNB6
ADTvy9fK7aEL31yaD5FlQS7kmsrgNCI3cqePGveXZp+FXfpF+vU+jbXbQ+sNcbHFBsAidccmlVnN
3cruIyyFDXWuwVHN2Glo8+DkEO9vViUAG7WH+0RXstXApVNrmeaCBAL+vz5ZKTFROcu6LrIL86Xs
KNCK5pEOWJxqPNbMfpo597Ms/dpnWMQV83BIn9O83VDMK3mM5SsANwAWDUVXVf8Xc87TuC+7qHGK
0Bl3MJR+n2M9yzfLfDY03cc25aBGT8DG6Vfe9YquYna1zKulHOsu6v9KL/QsP9OiCkN75tB+Zm/u
bmK7EdUp06cicLfClBWre3VqT8kTFclsw+iCus71H83wW8pDgu3vo9HuoMWn9gHDtDADJ7RgdO8f
/FaTL3UkA9MQATLEZnnFEo4AXbnp0ICy+G3bRyKPWYWKZu/Pbbu7T+pmRzugale0yDWHYRholiEC
AIctM5kOVfzSWW9CYoxB4YtC+lOt+dXPb6Z8EW2CjMZTQX+hCNnI3bjBZlunNq+/xJpQ12+ToYsI
G442xTSI8ZDbPwqCVREW3yC2Eiss50YqHGoJ96kGoZ3ZuBhyWHRR5eTkt2dK/YR8EZ38udSbv/3c
yybgEzYF7DIMd+h9L05145g1jSj31oCJ1XOcFtVr3aFElRS29bMVaZX7fMzdj2UhSIXBDJm0d7ND
+NlKG9KGs5Vl2sHQ86o4sNLu9ePYOqn56GmCvXBTCnPDI7hZmvb+uGSpTlqILhEIXF9p29NsJPaE
x/X1XXkYH9IX88F9iE/6rjpqPie+7A/O48fyp5P49jF0N3LTq/oLuaD/9wEKJ2Nt1NjYYu6i7muV
7i0/OZNdkT2O469Zf0jr3nePTR1mxsbBb+MePK5JAEtBbwKaBVSmrmSa9Qzn7nmfB5UTx35PRPEw
uvHwxS3iJNqQouUiFXfhiqDKu5koG4oxQ1E61n7B6wcCHI5Ljplbhh2yjsX4VmAqvbbVnrViX1Hi
QNMBfkeGVR3eBDnNvcogXcQLYgZZkknfHuZkf/94a3oYiHkYAAdFI1u1r5rdNZ3u5n1UF48d/xaT
P8Tc8PRW0ngIMC5oKJ6CGyeunnSg4dhf9SGq89PQ7LAkuX6SGFnQPgII037GNpxH0n5o6h8JANj3
D7mq7y+/QLE2gsg56WXWw0s/saT/gM0QYdb8YRl6onfdo2d2j43sP3XZ1qyGtUdE/gfsuvTMY07S
tZRWrCVUa+o+0mZP/1imcF/QGRB/vn++VSpIKSATjyIR8qXXVDCjJqkr0vSRjZW/x5w09dFGJ/EG
PHElVEZWDw4sBkAAkYnyyjWZuBnSuMrMPkLv3t764R2coAzIsXozg+4Z64vvH+p9G7gqeJfklLtj
5tD1FSd9JDlabm0+ZpgaO/bfLemwcK7S/qlqtPkFrYRo2TcN8Wg6MfJAWLAcYGAP381z0oXIaejP
aN9OUcEuvGM+imGvs1nuWw19uBaJ67ca22OfsSoZ49UTvtVCdOtgAei/4NVRPQAygKhTNCeEPlbL
vSEqtIr9NuucBUI2xmspE+NpbqsYfdhmjskGbSExgKeau5OBabK/7l/mjZjjKxBmvbdKY9KeGm31
pju0U5pLwMfNI8dckoYlx67bmpZ0w4gLGbAhcnQmmrHV0rfGJgC1SC8h6Xb+NfE6Z8RcF4leh/vH
uTEC73SQXsa85yU5pehkUxNZIqdGRjWq0GFuFn/FgImAVj7ZfszL8D611cvDULv/S2059UUmlaSe
LbDwF6eiIg6ok2u7OceU9waJkn9Vx+8HQ5lp6TJGy6xiVEVWN2NctzJCycGvSXzKiyF0+bxhvNff
6T8yihGtAfpJTczNiphnf0Jre3wiA2Uben/12jAAAIOEyeKtKFqJ672sOBtwbWlzEMa4c+rmJD1j
d/91VnnhPzIqSKunVuYNaCuNOvKnG06STsGQfqzJuEFn4zjqTkE3mytbs/E0HjqVXVQz0rb3nY5s
qL1Fq11pPeSRIENIRwLdg+ZDRclWNCM8i0cZ6WnNvpVujImmrIkHX+rOsLOAEQ9jTqbQyrOtLMLK
CTEuC9U9jKIAfEmN6PMKWwxcbOqMeq0NsNbI751mZ6Br+v6DrZ0QA1ShKbDdApPVls+4ECdmcNya
UY5IZu0qKyLt5HOsBw0ahqP1HmDixVbnzgqPLKPz0ckJuAZ8VuVSSdVihiCZR6BGzMKvm770XT39
w1mJ3oyxmx7un3CLnGK5sGrQHFJHjpGUck/dufU7zA/ArphiDO3Y27DLK8KMBncwDLIj6Nm9gU91
pBEm08dI5MWDpQ8HFLf+FT76vtz3PxKKKFs9kZgXR8bIyb9YrQxb7UNm/YjjcoM1Vjnwv6O8G9ML
1hBND1Q2Mccoy79gKckOy36xh2T6d8UE/QpHxkCdwcJ0mmsGpH3quW3nggGTLjC730b7OZ6j+yyw
dpJLGsqNVT0bpSi1MRrbCV1hWdA3yAzHb/epLHyrKgvMy35HQqGIoCoLoVWAdjdsihDM6h9Zp2kh
PMD0oa6MYqc1nDw78SQ3Ut5r8otZB0hDo+QHBKIivzXt+h5tqSPqyBb631CYKyCzrJ6m/cyt5pft
cutLWY7VXjItbo/3j7zmUAH9AbAggPFolrEX4bvgkVqbZ63QcLMSeWJvftDMJxvrkcrhOAyzL0ka
9fYDlRth59pNozyE4sV7bUHNkzk2xtmkMp0iq48sLd/1GF3Qf5fOSbJP9w+4pjxQvnDQngP0HPpq
r8/HM1SJGGVj5FL4itiOusdOCMd3y0IPzNjaqoavvSYmHjtgI0xuQiLympxbZJMUmjlFU2K2EW3l
yH07bZxhT9k05/7QeOboT8mEHSexUyZbBai1i4XFwdAoNH3gVRWPx8rnzBADmaO5ap5kzUOvoA+Y
QfAn18Zv0KNbKuaGHvIGlo2tBhZAJSj+K9c76BbawwBZihjBsWzpY+xm0Aw/NfZLiB//+JQLLaRW
bUAe4Pyr/YeGOQMdpnkIfLncCwBT2DgG85AcCdlgz1upACnMazBcwN+QFlGxBmUmB7c1myFynH7n
yA9g14MVj/s+/p27lZ/0SFox/ql3ttYrLIrsSgVZKDssKQogg5A/V3ErbgFrl0m0BuVVEoz8p8dO
aJULctjwb0NsH/p/9vfQ4QgTgbZOgFkwHUnx/XNMEZ1LwfWoMZ4qLPeIWXUmY7ov8605IjeS+E4J
G3cw2ojihApremgdbbIy1TEd5wuGv9bTIU0wsHLTIVq5QszQRxcDQYIAxWCFTmLwcWQz1dG86T5X
pNs5RYrEo1+7jd9hOHQ1pj/LYsNrWDvcJVFyLfdGAoA62qn1KGnR2sCOevIb8j+ZP/9ZBNBDjILi
MmIIWQPF1qaiYz2G+OkR+63rvU/SN4fUwWRuWIUbLQYFBtiUhxAXQHJYpuvTVNi6IA3syI4qxr6R
yfK7Miws49liw1NGgp5tDdm6TSkBEIFeNfRrImSDH6EcLBmMRDdHy4ogjfu5mwKztA9eTgOB4ZWp
RjCkegz0vvpY60iK8l/3r/U2p4Z1JlgH5eBWl9nRanA1AG5T2s7sRV3bHzr2LLABQjRAwxS7Uv9I
+d9q/JbOZ3GozYeUZzvH+a69euXu/mcsyvJa+BfAlwf9hj4zfIsii8CrmSLOnTjKtQbLNByhPUrk
IXAXxlYW8VZvY6olEArYDbJ4PO9J/wuzz71pqQMS9rHQMf/oiWovqDVOWMkcZ5/vH+o2s710FIGT
wLAwwDdBuETHSuFOPf9otrl9SpL6q5TceEZXE9nbQiu+0JwY4aSbedDm+nysDeelzWR7ykSHJJS2
Nez+5pYBM0Y2APgUxIQAoC4/vzi6XZkoTxr4nsF7aYdPUshd5pr7jVPfiNACZgZIbSkjA+6jph4y
A/LC3k+dhMVf92UIf6Ko8JcH8luZ7sYq8Px854Y09cfXeGtu+K39eqcOta4jdQRYnlLOqIgRw+8f
+McRY/X7+ZNbfGT9GTNadxn5W1bNjpDBn7b6Cm9Cp4UqQUZz6YGC7VT4VyeJW5IcN5vV2PI9WUFn
i3DjXhftfSUjCo3lGy5eD6cSw8SW1/sK14oEaUh3vPSHv5Vffd6sytxUKxRqCq9oPBdk0Dv+sd9J
uUu1wAn7MAmMHgtSQm93/2wqyyDD5wEVhsr5gla+gaWg+mMPll3JT1r8ve5/TfQlq/xm8VWfS7ER
GqpG8p0WNqEuQCkMW1YHAUwupgMz0ctPpEvR/Zz7mev4xsxfnF8DVkjlSdCTjTjxJuGt0lRsZNKM
pCrJID+ZsfbLBDA3PpRVtpfJqczbgzZjlFH/fzj7siW3dWXZL2IE5+EVHDW11C2xB78wut02Z4Lz
9PUn2fvetSWKR7zrRjhsP6kAECgUqrIykbPletC+jQZfr4LT5if/PwPAEoMNG8+7+bU25nXdJFzd
XVJxJ0abosFTB6S+R/bA1WbY6zQHEUK+44BiEUcIL4//9nUwH8DsdQCJoUIcmAIrEDCmBDWEXsos
7yQWno0a6JOSie+Pt9TajGfX6kQeF0UyPnM0APPNVZsi1fZSsyZdcXd9zyc2bberU8ngzUO1CCs7
MJWDNIPBFinJ5U3I9KAdE9DBMRK1DaxIIula8+r/sq/++azz2q3X80o3iJhknVgHWdZzU8NL790c
3XPlrPifxTM6MbqBoBB14jmfC4OWdqatYEtJPwrWqeNzphBmQI/k62r/2dzV/Szq1P2I1i8RnFAz
Jx4Gfs+HbNnhivrThQcZNECeoOeZkcb7pCJg5/xL67+PN8zyYkpTdQ3zQ/lrdkhbWmds3eKQNoM+
qJ0pWBJ6YXLSNjqjkVZy1KbeNLUT/Hls+A7r/p/Z/tfw7PLIC02FCk2HwzluOPBOeL2L3n5S5/CB
8IOBnOs1jQDofKWMv0uyTdcd8lp1ND7QO4jqjWG+icRLUJwK9swDd9bz4Pskvdejot2SWHTU9vXx
mKcw+Poumg95dhdVRVf3DcVaya2RbCZxVr9zamR7H5tZWpopKMUfUB4gxTuN4+p0IfdFm1Go+kuk
HSQrMLNGF6qcpK94EAKOkARGAi5OOX1OvipXKy/olzSF0SNU8048c6D9WaYHZI+35ZPcnPrR7gTk
BNaqVQtHAzAgpAFxm4CddA5tRrtHwOXMtBp2Om57EKEKmyJMjEE8FtIaDHDZGOCvLBCH902uXjj2
MZNKOIcZyTLHFzo0nxI5/s0CiZO10conWPjSmNt/zc38m8xlXEobsbtopNx7toWurMffeGU+81Rt
1EtSPhZsd8nRAFewsjlkn/7Wt6UxI0nXWo+tTRtztnGvpzN/iqMTvxNBZtRddhJpV5bqjmMIp+Lm
x2ceRMyFGm3B+HE+OntsZfJKZSe1uMl8tMiizaqqj8AEKvUGNOe616OLvJj6OcpjifYBPqwP4AZe
Wd27ePg/Y5peV5MOJ4BMtydIQkrMh6YF9iZLT5ri5U9AaaPG3ta8oqvoCvtoOelPEfvKFiJ8JehH
myw4PV70+ZPrZwzIe2AAUNXFW+h2DEBSN1ogYMvmxXPAv7CQrwp02fd1kV95vi85ccB6/mtqFmdE
BdQlSkHG6SiUY5E59TtSdMYQVnuW2Ya/S8mIDl4PMpi18HxxY6EGhQYvhBa4um7nKMSeV5YcA8MN
VQmjdSIoRaM1fvcfgPbd/r0yM4U9Vw6x6rM8GlSvu7CDo4aD1VY7QF9ydIZ8+I1dNsdmp46Q+iHJ
0Bhl9smtLPCPPPGjAcy+ZZ1zUZlIQX9JNr3VXpqYAF1qNnal16ejZAnWL4aMxiFiyWA8tYlT672N
riwiU+f58a5aPm6iiPwJQNigJJltbd8b0mZQ4v7CJ099rScVEGwDpNSMpHyPIhvxH6nEl+K9rmoi
jLo3PmnNS6033sfjgfwQGNytydVAZnm3IqZ0hNxXf5GOSDO/Y/25lyp1auUwcnaKdowEX+QFwpIt
knF8tx/jF6606hFa5o1RF9YoGfEx4Hw9y9zHQ1uIggEWn1LHwCRPrG6z7YIQWFPDsL8g//0easX3
UO+C9POxkcXjjdo8sv44esik3hoB6GmQuAjfAd1wDEFKFcUGNjSAuDapV+9RaV5xtItnDewYwGUi
T4yL99Zg1sdtlzZRfym6LNoK1Rh/DkGUrbRfLa7dlZXZ2vUa9G8UrsDaxY249zrR3+UCyGepVGvn
xysoChjx3Q5Cbh/BzgR4mWfd1YbNyrDGEiKeaq3aGra8zdus7bmMBcDtO3aL1f82og27rcxhOFLb
37/Fm8HSfjWWv8nNxuJslAb+Bp8SuvSaDf5uzXNoJfpaQLD04tHwUP9nrLPPLYDIRpRzeICIR9vs
ALCzjFjz4OfPMc8TtXAAnawP4svjJVq+yK7Mzjy7V0QC6v3Yykx+CNlf1Du3wkbNjhJKS+kp5+Bl
Hltc/P5XBqfA5crV0ljl4kBN+ovShsOW9iADpk1bbmQ1lNZu6WnN7r8/VBamxl2c09nkSj4Dc1NY
9hdqdtva4u3sxBnMb/k8fd3sL93LVmavCZIsnttJ2uH/GJ1NEM3oSN8JGfwn03m7CFTnel5SEVDG
QCIBFXy0DbTK2lT5lanOAsqUZhX68TBVUKeZvSPVIHztj6XTUavMDlJi8h4BwTCTrnmN5e/5z3Tn
j0quQaTpCfDSrFQfebwbBmqqTLfiDP+X4/FfM/PLIGGkpKnz/qJqp4GeYk3VW3YbeoRXvv2PFq2I
Cndm1mLPn6zq3Q5CLR1pfHGiGZ+dSpB/xVzjw2zIOn6q6UqN2kVo8yiEwhlvpH7Uaw9d0AgSMt8A
FM4QuVOVfWjVZ6FsmE+f+cv3O5Ei0bcutry49FeDm21vrmTaLBZwlFLP9CO7QkI2uqgiaD43qQlR
czW2qCHFu6hRSY1+Am0FdrK406/sz3Y6E2pZVzP49GD60kMzpftYMeu81JV8Lb24eJJRegOsHIEg
she3XoOBnHQrlrg1PPGdHxy5+ZCZhAT2Y9/0v3zu/5qZXYEe6KFGVpwexowlim+aGIBW8Vynx0pi
zSIyJIQ8PDoNVCPBXpOwIVQoHFHEH6nisBQ8PjlJwh0XtzofrnG0rK3B7OYMGbFQ+bbuLy0yFGIM
oKpnSQx9bhB4P16Hu/LVz9Piarln2773qNJybINbAZRIUbiPtaeiiD5y7aRFTubnu5H9EMaXlN1G
teM1DZgvqi2j7gttrX69NGnoPePCAN0GFD4nv3d1XYRqUPcSHeBelKL/FMN2siP2Rp/L3L5NU2lt
lZceztcGZzsNvLliFEDQ4+I/VfJJYGsC1HkTWiFUMVE6fLzQSycI0iQsoKTIz6Pd8XZ2IF0Q+J56
OMGfPv2ayrxogm0Kxe6+/r0hZdKoECAkAxjJ7IN6jNSpfN4Nl74oAM6GE2MaNy87Z6ThURXXvPX0
Rpi7TShECEjaoCrGz6GKYLSsRa8VhstIFTtu3K5PrXRsdbXZCtpOy7mtEP7VsrWWqiWHeG12tpw+
VwuxFCjDJeSflWobFu9xbD1eyKXtcWVCmr2ORqkfaMbIw6Wt3rv2WJY96F6tMBGJGl/KeO12Xdog
yJpCHRObBHWV2ZkHUVchMJQZLnWANE6MZ5/yzDeO2jVOUA7G47ndG0NDloBYGUgfxKLC7Kz5Ktp7
AyAVL+LgDKXV8p/CL8oTJV65N+7P9K2d+RFT4ygJfdhhtG2t/BqV95zqw8vjydy/Zm6NzFx53SZS
MgATeQHIqNB50WO3DB3WAOELD3eYAZPYVP1BNnWe3tZibmDBOopHKiCyvfqF6KdHb1dvjozhV4QZ
2w1958NvZnhNpZ0CMmBkEPIAQEA/R54qcoL6dxD+Eb1dOWwzKADw4oanho+bpms6vVhblvv9ezve
2drTLgwlpRvhcehpGJ9rpzJamVDekP0Vspk1S7MPkPpSV3UFLJXKJlA3sVSYsf8GYWqdBStzJq9g
5vlpd976HMwMFwTSYejkEeadZ5gUE8S9hpnFyUFoA/CQmGV77gGPK7rmnLFgFLG6CuQ28UjQbRiJ
IPb1kWjxwNW/aVoI+31G2WeAzC+Infh/C7cHtSvcPOofAAKDSuInxXZ1kXWtqsp9xQ+og3CeqZbF
QGJw5eltHP15vPPvGixharpS0D8AeBvoz2ZuEOgOtQKCgL+I6GpnwajSWz41leGsSS+jbObFsZUD
dPSeS1/SM+AJ6XPOPAMqL4d/I2kHepjfqfqt8M9i9iE377KAznHfovXKBllwA9fDnGMKfC6HC/NE
/tKKMW9x8mjWShFukXCNT+ggDFe82w/j2e0Gwf0HIBxgFCiBIbd1e9lCpyRJY6ABLztKkE4ryFHW
v76+RP3rtH97e/v4+Hh6+ty6SLGRvx1J9O9//VlgH3kcbARs0jtkbB7Icqdxo3QJ9imRiGz3lmRV
enrw7dAGMsX2LOEltUdH3nAmPcomaysRScCN0ziPh7Lw6gcvHmQmp3AA75q5OE2o+VDl1BL5IhGU
qK26MD3fzEzmo3JWkVj3sQDKmrhP0F01ES7NG+m5IFJCAMflC7sNPjRrdGqSP2Wm7JT6yqymfT3/
wMA8gwQMZAtIXc4uSyB+ImFoNPlCyXHQG9Lp70ef/BFJYZz2H9uAdOT1sckf+O2dSVAMoiNjit9+
roerU600SpfnPJUvxu5Qni5H65d1MBJ90LWQfFmbIwRrycUicCsv1clxHN3ZmqZNIkzeeN6t3KsL
aWws9dVoZgcffXMZw9JcvigkNGlrVC544cNL5Og6hGW3CbJJ22jlzbRmdN7ggx3NaX2PJcCD81X/
NXwViSm8CfvxKfNJ+wqKeHr2zyvrPl1TD9Z93u3DhhGe4EGBdTcOxq/D0ToeM8M6BjpDfhXka1p0
K9VVgdBN+WRg3c8R0T95Qo/Os3RqiLOyEX4wAfcDAvkgXikg0JmTG4MGQ/YHNJVfvEPzcrDKfRJa
+zeIDZr22Bk69+c50eO/wxZg38dLsbjpgff/v4YnL3u1A4N6QHqYh+GRM3idHrRz2dpFjPe/VQvv
j20t1IGwwUAmAk4riM+ARvnWWK81BQ3ZGicsJeO+1dxuBOr81PsH7w2EcNFLsIuHlaW9j0oBtQfe
De2KwBPfNQcpUHDswt5XLzm+qGS6ub3GOLO0hW9MTKHM1RpmodZnnecpF9YWtxrOTmSFJqO35O0N
1TRHdFahGPcvldtJzU4qgAiNkPiMcumN1uh032Geyl3sci+8QS1sUCc7rLEr/7i/2RYFHyjYlwCK
RQgy57KSuWLg/aTCLHUAL3aBrpmF/hVAFpHRE4Lyv0WtjLwUNtSo7OoANIQ1rUFq+4S1XhIjdCKj
JyfJLklkRs8Bgb4hmUbf4H+5HRqgSNHfBsDZup20SQ7MBgRdlqcHm8LsyJmx1BWHv7gzriY0241y
WqYho5TKxcgt/9mlx2TFwE+BYLZkE62NhmgS+E7AL283BngquDptFeVSG6Iu7LwTWFCsyMKKmaMT
/0Kfs+NvK5t7q6ySqDtqBTtIw9i1HeMjei881oG1G8d76tbv1QUXiFoNXi+TvCkKNtPqXG3aSG1D
SKiG6kUgg9mYv8qNYo173iT+JQl17+3x0V9IjQEbcWVudkZgLk3GLFIvjdnuKzvQLcVEHoho5ic1
QguasSZiaqKsRG13fKvA3N/YnZ0U36ugUSNgmrKtbusNfQpJT1pSmm/FprXbJ898PNEFfwrhGCDH
gRoHyngeGo1lqFZR0qsXz44MwQHzAFEt1ilWQrA1M7NgVFALDllTmEEY6PQb/1mzIwek6h+PZ7NQ
zYW68tV0Zm/6RMU7oeg69fKebVoSWPGzt9Fe/IO8H+3GyIiCKxJJzQ9uzfD9cwyGQT8MsmcQxCKX
eLs9ZYTyNJEG9VLvi638CTZRozTBzGGDcv+3dHo8zWnzzc+piCgMhVL0udzR9rCRV3BdG2gXoTBD
kcBDoYg2Eax3K7ftUuSM7PN/Lc3W06+FgI5+pF20wOx0KQCudT+xVTRn2ew4nV8J6SYXdj8x8JPh
I+LendMTVBBOq8c00y7ZPjrLZ94Y/79W7h8D82p/TUHX7E0G5APjcBbz4u9ZS1zZ7MurhocGFDMg
1QqRmNlm8H0w/4H+7yIe2M8CEq3l3+glM/kXfuVNuWgJUQIAQ+DchBbNzFKTemKj1J12KSkpXqLf
Sk2QJU9IF5DxU1lZvEXndG1tluOoY7kNJa/RkJ6b4GJ8Qeiz/8wdyp3yBB2h8pcQEQiErL3wFy6+
KRT6Z5Kzh07UMKrHczCrHetjdBa/uT8Nu7LTlxzUtY3Z5arRXAFBVashoA3Q3f4pPanH8i+16pVG
p4VaA0RuUdSZXqPitMlv9wYXeuAzSTPvYsQVSU6du+FPg6FLerXnzG14TNzHvmIhUQSDqHCAjQWE
oniL3xpM2DZj1BoG2S14qu0AT1Jp1+D+DFAVDkxoAFopMACCnh4hx7Drvhjr8QjupJSnO+16BLO1
zera74ccIygNCmImopiBJXxVtrx5e+KN1NA+Ejeyi3/tS4CDmIpnwJSgE3AuWjOoZcqNiuRdFHa0
PH5TlNx2/AuaiZXpTaO/9VnAo/2o1k/EEqjZ3K5vKRdV1eQVc2G1fIs49Hcx+oqTZmlr5ny/xuAy
/dqNNTSHgD0RhPMcJFvveqwHIZZDNo/5S8LACcddmRnUk9CQIjRrpF4/bMkzW+Ik4Sjgof/T1nU7
Mz4APGYYBenCjE9csWXznRptco0oYQZ5xTfP+w5DR4sOLGAm/nnsT+ATkngXUZquCHb/zULY0lG8
c57oo8uhgo1//5SflDqaegbrGVtA2mw3oA+l8SzPN5rKqNG8IEcEPEhA9zdvcQLFQTB1IDBPUQNz
+3gn+CsInbvLFMWGH1ELUO5O7RyTZ7gKLMWmrMGihhdlFqieWVRDaxQK0ohR3jAm+AgLJ+DBuVg0
g7eyc5Ys/6juQv8FPblzxK8o9YLkMaV8kXuGs/keqpW+wOebqscih5KW2koVZ88S+L70x0dy6dNK
EwAQYd9P+nR2b3RggYJIgioDfgOcBAc6Io+w8VbKXAGi2Ic0sBq69WNdjg6jv43UYwZCm4I7sJ0O
DtuA0ceASF/asBtHqyqJL584SJDL+S/ed2LVFNqQVBZDX5O/YXFIa09H2rlJPvxUbyXSxLq649+z
rSQ+s+poQRjC66xS3U8SEY8neh/H/+zgiYYXqT8QHs0mKovQRalHpOMilj/h/VQCe5wIRlPkvgMe
jsEo24QH+5bQbgqpeq4TmTXioTj7ctoYaANTdUnzjC7N/qbTDEWfUr0WUgW9U6BqJgUa9EmbKf3m
8bjvASAT1g48o3CdAELBe97uSiEAx8Xoq4krVGqy0SAU/sQz8iZIICkcAsDe9h6YmtBSDS5hwUZI
nEOEIVrjh7yPLyCmAfqX6TE4ZZLnzq2lAMpH5ehd8iiF+idHnyMcWbHsCEVjQYEvGcv1KVBewzVm
vfvkC0xD5gBqY0i84Oqan0tPFgq2ZH03pbbX6YLTcVbL2l1thG5XbwHHlLw/4mqX1bQhbp3exNgM
atypzxr8LNOhvXIHckwFNq4y340aTTVZBuWizmM9c6BtYFchh0botqqcMfDELR8wrYW+EtJEY26o
QuCZWlfUa+HkFGTPhoR3LzQ4NNArIps+28NiW2ehHFW+W8YiMm1RpctsLOkg7JGsUqCD1QBSaMR1
odqaz456FFWZVYdRtFEHfg2hcJ8kmNj/sCdx90ANA23OtwvkR2yYN4D/uNxZDfQ0Pgx/2YrEo85S
O8I7SzTQ6peB49c7cqJZ+RagORQClmx6TOhvfg/6QDF30shM0JmM6tj30NpStKWSqXA7STA07VVx
fVFXmLV1nEKr+ToiWYneHNzTINCa7ahUklqfph121Cto4gMf711hD8Fs5akQNVLV77T7M+yi0U7l
tY7SnwztnW28PlGhwt+A096u2iB0fOuPue/y6hOch2f4LwMDaBwJ8m2j6nzrxOKplizWM3ij/Eye
2ZfuVTQHUPREO05XTJEnwkm6pKrReWCeNzVZX4Nl3wdq06e9GuQsUBObQlKCgvpuD79yZCq7F0xB
2foHCXXD+siZ4i59G98F31GeGXj90uB0Vlr5TD+UKbOlAs8ITuEEYp3wG7dLJWSR3zWS6rtVF5v0
eShes8Lsfdujuuz9qZl9m9tF8wEGFCKI+2D4XbKGzNkKcEG9RLjMRo6hhQjDvsBzhM3NpDVExh5B
Gx49JYkZeScKcrbSZGKngSxIYkrPwjcqpN5Ze6mjTVmhawrJXeaPKD8HIB1vuEOzHesPRSO9Dw7+
DRp0h4aw2baW1jCcPwztjyY/8/sik7ZiGoq+Kx8q2UKzI6n6l9A/aK0eb8PorShI5qQx5LQbXNok
Dz+yU0SdWDLGYO/Xliy98b0xfMv+xmdAD2PU0HQdjAYeW6uOspdAb/MF3oZADdDnzWHqHtHD7qTI
liAS5ZcnbpTWhcQoRHSAMgzg7oa9rFjieMjyXQJcaUhaZuOreo7CMX3NSiNXzKLflXaoPOfvaFJ5
fBMu3OBTOz8A+uD3Rm5lziY+gBzJZxnZd+vYkgsd2PjC30REaw2AtRIomNtqrQ8HWqNdzUT7W6Vn
6OfayuC/Hw5itTKcpWvpZjiz+yHJNOp3lee7wyEFT7RiVbHRoYgOGRkavIJ5QRRNkYXoEV+umJ7c
093WuFqImftqEr4fU5HxXSYjaZqAwynXtUohkmxVGSmzlLTJWkPK/ZMfsTGifzh7DlgFEB7cHsbG
HwWxLP3ArdknBjdPNPaHwFdJlQNPkZFeyM0YlGmghdhyCJpbFccxGDaausbTdv9wxkjAtTClAab8
2rzlOo1yvhAbIXCpCp4cHlWMJ6nhe7toFU7vhirbV0qiXijXnfyarXeZ5vcGTYeeyAHHv1O50fSB
TWKDLzj6nTOQ+Xm8UxdHOKkHsHgNskDvzbYG+pGUMK2C0G08wSlDtNYrpQ4oe6XYeWUFTWtWzCaL
WiOgLxHzmpR7rbRiBXDlr5WR3L8SIQwF+eqpmwLwrbnqoZyLAiTPaOzKdgxIE/emWMMBzioWIZu5
4SUHGcOP+ChtIvex5XuAEMrsiBbBiYzKLOqCs1ilBRaDhxpo4srFU6ZZpb9TZIfGJ8VzBfl3pBxS
CIeg3YJ9qmWzUisj89j3nL/0OTWCDLR7AgXQ9L1jgaxOPF3Nwy1MZYQBN5r0Hai23wYrD8C79NJs
yFPYcBXxcVAyZxB3xS4vp4Lbww1ZUVdVQPEk4JAuIyi39zTYPF6ou6wBjIKgaJLlBDz+TlKXAckV
WIPKxC0BidhXaySh01ab+Yqbn59dIyHflcCp4+e54UkZXrtvRdjmT62qryX2f2pCt5aQhUC/DsBI
yH0jx3S7ekqZelQI4sQdknHrRwdx2HKlcvCafeEWo2h29CMfnFZHbGEwond5vIwLDxS8nae+LRnk
DxxUVG/NpzwjNl7gBW7JGSVPoo6A2jDprDY5ZGVE0tJm13pX7vfLrclZlJQMKuNBCTNwxwDahjzk
myDUUBcf4yj9YZBkejzD+6MMyDnEkEXQYIJrYp7h7VPaozqthK4QdIkRNGNFWMrqDGSdVvzXfVEf
qTL4ViD7NEgvQOLidi0plEB66AFELs12g/zst6Peo7WU5/8goyN9tq2ZZGZhcRDd3cvqUYO2+qHH
tdNUJON38VoFdyEcRY4U9L2TuwcD6JxpRqnzKOKZJHJr5tBN9BK8njIv0rNnMSPJs016VFGSHEh1
ElxNPpW94+dI8/VEWWPsvK8rYWlAf47ULBiSkTeZnaec7dOS5nXkluJ3nl/a8rliTkIq6VCG8EMi
e2jqj1ypNwTUisWtpyE6ix2+4Qm/xnK0tP0mhwH8JWo/uGxuv1JMi77j2A4wKUFAOKQ1mV0KUQ1c
Lh2dSCkSUE1hfR7vwiWjYA6XQXQGsCH4x26NSnEVcGkQxm4SqNDRayt20zUfXN3ugEIa8cSLtBWL
CxmQH/4EfHmwe09cEbcmh8ILK2/Aqo7ib3HYDAq0+FK8N8SKpOcewXgVmlxjqmuw4KUDJ0HSEy34
7JQdm4VZfNfkER7hkavI7XjgwHASp+h1qctxxXdN98rMc/Kg4UZIgxAL/84mKDQdO0BQKEaCIyCs
EMJ5rVwyS875xsT0Wa+uNg++GV3+UewGFUe4Hy4jxO3fAqALr2z2MQiQSiVVvI960q+UppZ2zPXs
ZsGQ7AsawqEidtVcUkDN0jN6lHCAJOUKnrsKVfUkSlP7329TcKhOvUugecN1cDvfMQi4kdWq2K2H
CA2zF08ojEDw9ajPcR7TtS16f8si5T8R0KNeCZ0jdb68tI2DkWKOaFflLIqeA1JnfbEdufGFCUuG
NI0SGz5iVYeD6B6hEIswRLAvGTUDdrRSHTMzBsbeair5W4kGYdeETLhLR361pX1yUHebDeWm//C0
gcHndmVqEGPk6cjhc6S7RkLaFa16RBWeKoqu5i1aU9nKjtf4ehb3H5ZIYHmoJCLzMbtRWCoNgjhI
saulleFDyUYrzsyop9kFuW6htBq80Ht1V7EGen5Zfy0Kmo7qfNLooZtqoxpINeZsMzXr8fnI54nL
0jY8MFRFC7WaJKdIDNzYC9ljNtLRllQv1Ye8+/jXexH5C9TdgNCUECDN5i4Jfpz3eZ24oCZCt+1O
kIyuMMUMlCy/Hlu6bx3HFrw2NfMkTA89yhj0cC5/QM/l5l1JrNoz35r3UAeBgJlYaMLc5rGu6JmZ
HiGLOTj+UV6tRk9mZssNnDGcGcgPJ4LK2elrPWgXxmGSukhPVwblOTKMMUkU8/F0FzzLjZmZgy5U
mqRRF6duOkboUt6Cayrgd2CP6ddynfdIOSzs1YzmwS1f+AHbqDAlnHl7BE33m/oh+UQ1GEWvQWlM
QqvvCGpf58dTvC/aToYR9aCRWwExwU9S5MpxBwIDWaYwT13AzUwk3D8HtzpE1p/oWBEL1GkAl4D3
+iTvwBk97HB/rAVfC5fTzQD4W38hDXIIDGGWuiXETskga4npg3LQejzPhWzK7TxncYUvUiD3c5q6
OVTFTk1nFCTnTTUjuWoxvFNd+HIrZ86K1cUddLW6M2coq1UpiRompxy/y98pQW0qNsT3XkcmeFPq
wlY3h6/nx0YX7gosqMoCEwL5GZDj3i4o6/M+OAzq1GUgXa33hf+FSyOzvaaN9bANGbvp+F4XM7oG
KF1IPU/PcWBqACxDTlWbHUtUcHwUiprETZoiOEZ1n3O4in2x0f2c4QDGkopRPU+5t1efjSEl0Ce0
lPY5pTWFMlWcvgZ+1H7HjFa133jvVQNS0W3DgJJDU0G0mUqFGJKSE/PSYCNZGQ++BIEbOyyrXEYx
otN+MwJiZauPqUiRUtQkk0v64EvoQx9K4n1Uxgfo2/WZTjMZN4Io1VlnPF7+xaM8kYDhlkZ/M4pK
t+vP01aSirxIXGQSaqY11IpwPugRvGdF07u9hIK1qsch2KA6Hf29qwJKPxyoc+94PYDZE0IU2SxK
QHviDpHTSCwgpBATJ5AAgv6iAEmlgii/Vd7qLRXwUpRGrKAi0o5prNyu/5bMe/CKVU4gcOVjxUOi
pedCPqDa8nidFocJqDOEe8CAjQzObLd0aHwd8mhMwB72J/yEdtaeCUQIeJVW2BhtZ8klaVWCR5Je
+I1eSu+M95QCid3qWplAPwkz2nieiTIlmG7LeNP2mzLEjQ/+YMJGl5XRLp1kUE0jvAAduoyX2e1X
bZAgZ8aeS1w6OIW8a4qYxIGF/KCAXuZI+NN0oTlprbURR9r4fchI7G1DcG3HaP9BAbPYqMIrNDrk
Dt1sb0P0MgDekBplwZBurei+5AHwhsJDHu/56el2O1YmKMNuiLTERVW/NfxGzo0iHTyiYclNlFNl
kiQpdcqSWWPHmlZhvvXgc4BTmRpyIH91azkpqVfEsohVklnfqXqhAtBgGJ+ktMhXLuelGACFRyg/
IPoGZ9ksJM6VwpfKMYRDFzhR78tmMCONvqLMs2XjYq1csnh/IKiF2PekOw1ymtuZMYgvwwY8Li6b
os2J06yoITVoseqLPFioB4Rv8WgMwdq1NTmL+YJem53djh7IuL2oaFK3kIlcnBTp0LA71cIBZeJd
3ttDaa9s9OkX7yxOdweAYzIAZLNP2EtFxQXBmLpDixwEkEXEq754gNUr0vBvKIaopwDRUGQyg9FW
umKxuEkB6teiDT/+5YatJ64MaSG4/pERk8C0zCJKmY2ILTgmbBgGsVGgQehmAFSBq6Uzz1TSQWC1
YAcdYl9nmTTUGyB2V56XS+mBHxJ7PLxQGgdX1u2XjxUviCU+zlwIERM5elcGVPdEh1G2gmBnfW0n
/nOpVmZYr7z6FqNtGOVFEahE5B5nHlLkUqCIWljuJNIXzxWbGRqkHrwIAo6QYWKpXslvbb1HLz/x
U0uSK7hGvAVzE232I4dCXmAlGnjFnvrwVU0M1tPBwvd4vywcQ3CQIwRHahA5q/kxZIZairiUy9wa
ij1QcvWrFpwYB20NX7NQHwKCCS9ubUpPQkVnFsAVRSOrUGHL3GRfnplNSirdB2L95YV7+V0Sfo3L
cSkneGNvtuu6MWvrMoA9Sg6BJf6dmjZe/oxPp3gvk7ecCLpbRf8Pt/fCib+xO7tosoyr1DHiM7f9
jXdALO6y4DNTbAk66aIa2iIEjT3pAI4utj9XzM7DcHIjic0erUPNjuYmTVaQpAvn72ZE0xa4eiIw
oyh7eHZmLorkU5dAbrRsil3fEy74U/WrZCGL9iRgDsFPiabOObvQMCShUuWwN/Ron3SQbCUbagfn
Ht8cyHqdJXp+mLpkzLbQdacjxne68yry+nhn/yAlZp5wik3+Gcfs+KUtWo4DDTtgBxoSov0PaV/W
GzmuNPuLBGhfXrXV6lUuu90vQntpiRK1Ubt+/RfywT2uonVKmLmYGUxjjHGKZJJMZkZG2AoKwjbo
XOF3n+3rpnaPOSCtpb0/Bf3bw8Na+nUpFXxhn7vG67xTKqma590GnBUchOyIV0uRbIZ9EWL4MR6F
xH2I3q6Pe6nScW6XZx4iYwuWCYJxtw505dBkj0e2Q0MvnjausrtubCGsurDFX6tqT6gZY4ymcejA
Aps09+H4PESfq8CYpRTRhan54jtz48xM1WJUMCzlLkN7DTIx6AzuDnWPp63N1NvkNySCu5t1jvf5
pLjiR3xhRYsiBBUxdvQobYvKbgtHvBGfxWmffgKZM6WuANqVwqsCWV/J1ywezt8ebHBnGNyn7+mE
2RWVB10ClC7xh8GRV4PjxTNrTmWD5BXACZ5Ng/W6oOoRMJ2acJgxj5qfQSlzK/vqToDUmDHXdlKf
/ZFfRK11RNO3klvkJzMUCS22xl4+u8zP6f7+GO64yluJxoOEdU7Kmw5y2njXCE4q+GiDp8DtHDJX
WMuLLXvxt8n552euNT96QS6DeVa0o5T4DXhR1V/AFUurVCILoT2c+NsSdybJ8sQSK4cv+bmLtkbR
Ce+cKdxe35RL9TnQVAL4PdfnACXjprCHnrOUlmp+evYLO7mL3fqGDHaT2c5+PnbAYrLtt4EDKt+1
+tcCCAfX/JlpbiotwYgiasyHruu3n6i6oWs092dS8l0OmXTH+Utvire+9CI/rR33+sCXL/0z69z0
6m3fQ8wCA2fvtVcSO9ZwqT45yrPo7q3WY/5Dbz8g0e6u0ZUvhzeo0QMHiuzND75yokB8g/R4zlDl
HezZg1K4eoVLbkKn+6NpPtfgVWwoGqN2OKUYdFPbZGXjLCAqTDwZwV8AFCwK7DwczlBpP+Yiy05D
ZyfmBmCbpr6JPGC3sH2d8TNL/TFxxXQzqTtrk96ACLhy8o3q6+YuP0qf0GBBIq05JGSbrzWiLZ1k
YB9AXgnHGYoKnFtASrWT+1TMTpbUoEu0QP6iGnOYTkowfTRrAMWFd6xqzDzeqmrJIMjlNsCIHFMF
hmJkfodxO2U0t4FNekCv+Oa6wynzd/OHFWYdWxq2AKPlDCkjMlWd3uQnsKYbb11pF8J9FtkWyo/P
0mtY2eJnXQ5O3dtluU93LPYBLJ+I07wPw0YsZ3UL3MxT5lJ1H6H4I+/TF/kIGln5HnR6IQ77v1Hm
4Y6J+4frn754n55/OrckYa+kTRu3uLp1FzxUTtU7egFExI3I0N0jJDsopxXb/q5Yabf5ScOiAq09
O4OB3D/OCu5WI+k4S2vjDAx1xzhako0aj0s6975wVEcDx+emsZHSqj7IBgqHiT12ngwMt/MOLv76
SNRdu6ZssJRFv/gkLmhHDBvH3YBPanx39ICm/fR3+v0mR0Pte/lX3aIDNfNF8Oq1jvx4fR2UpfDi
fDo4F4qlBlBaacJ9t9Mf0j+/1L935NE46LvsSBx2AIFh4/11atfZZ2BY1Xa3khPdOYqD/+7LLlk5
RZaeyyrOLwt1OLxbAfO4vAtFkEE1Y5UVJzUe02qXGC0Y/ZpQyX51oL57bsjc96KQsWJOKJM8aKdM
fB4bM/tVKBbkTK7PztK5AQ4HTUGiEfCdr4U7u5lHgAg0vKeKU9vEky/WRe6kavZeN6IWdEwcVl7D
C9sZxXzUASFZhH9EbvDWYCStVhvFyVAMdWcSCe8D5C9cQ7A0R6nMzKaMruVHvvIA3CGizfpQoGgB
Lgqn0OWUy6OUSmXbFCeZurpms8TDlmTFVnlk6NLcSFBvdKsbph8UaWuUdsoQm61xBiy9VjT0T4BR
QsTGBBjg8iOUMR5lrWyLk7DVpRuZ2T34YY4VGvZHkCw7rSvuatXLTU9u/QkaQO/GylNiyfNwiEIo
CrlHNBwZXICvxpFsxFpVnN7eUjAwZL+Lp8apfPJ23aUW0JfQwwRVx4yQVYwfl0OZy8okxhgpYG82
BlpPT5ABtRt4U4VUNDoQMh0dLJqTRkjGsMiZJk97Tq3WqTSy4t9L1QZQcyF9DuolyBH9GLRudKiw
5Fh7kC4X+9M+ENw9wOo2gpSP55Wjd+nMB1EIQDLgNoJGp8odvayLwRiijQWepAhMEAIcWGbruaPd
VqHdAg6FWNteC8oWXhfoqUJfDiJR9FfyrwtkwASpFcXi1Itl7wrVaNhyK6nbUgvBn17ko210SuQB
MPTUW1G4mbpVJN5PZQ900ILneOaggdIeouJL7+6kKgmx8/ENYSi+oJwkfOQD0EtuLocoJEmsiC0b
ARSEJyCaVtpWAaqw2zDVrHhThV2augBw5MBqDRRSotXYtsnRUggg3eKYyi95qagvxpCD51CM6762
VYNIuDOMQjpGPRUt25L7+DksZe2Z5XVX+5khqCely8s1cauluwwAClTWwQ0DaC3PMUnpoLLQKstT
ETuJ7kklpndyi1nhJXeE6k1+xecIexkEB/d9NXctOPpb/6vydaBoAZCGdJAOds/rm46/5NAchtP7
W7GMu+RUDYSpQgt9L2FAD5/yQTDd1y382En/MYEGNkCkADDlS/BKaGVt1HckqO1ylx7AHOF1+zax
O0902U2/FUBWoq2xDPEXxpdRUMlpqCohwfx1uZ/dT6RoDD2FglaQQPzSwSnuxgYejlVjPtYk/Z3J
0QqdH38h8ga5SIXSGL1fEWTZIrBIZRZaLuU3pv/Sy27FEB9C/8eQKlnQREaHIZ/1qAmjqawNJCCS
moALMRRsCpFWpzfFceUQXDPFnUpGTGUB6FUSjDQYBdMWrRC1tVXyXj6x8DUi1CoR28yqj1/3z9la
6VmUDpMcQtFO/IwKaaPHzUOdKXga7yktd8qfXq52AhVuU2O1PXLObp9f8bxt7m6jocLkxrBIoBrO
RB1igppHQlU0fKuEm2rmEt1F3dyVBALt6/tiwWHQkCGZYBKw5rbW+cvORh0xjehSh20hGsUuBW+m
pQ6WTXPpQWmbtSz/wkrOSQe8gWes9w9jtGiEFKRUJGBgcXLAuvYIevJ805nKyqgW9p0kIUhDgXS+
zfiQKe9Nig/BWkp3WhtUqkcUmzAvm1bsLA5I1SHfh+IVmPq4hAJFmxvg9wIJEChvBeuU0tvElFZi
7jmq5JwDmDPIuBjoJoXMEuf/bdSyuGU0CVRcy8mRNMwVpMdE2hQAYgIZ5irCWqw1/8prJudxn3lF
irZhSGPHSVD87UsnhoxI7pqvn/KHZDi6LVu2vq1XUZCzk/80CnGQuUMVrQDcJpDyCbpBcZYEEzgk
/ha32W+g/jfTDkpy6S4DC/JKuLM8r9/2ONevE61CFAR7Xbu3Xkr6gNYrgiaNypO1jfBxfZ+tGeMW
MWej0CRKmQRJbHllCMFltL4ZA54OQWbtemBGWpDiXLf5I2TGsQLP+R4ht4ydxpIW6NgkiMLebtWn
SrSH1C2V3qHK4KXhZ4R2ecija/3K7fCjns5b5i50qlNFHEb4rPRetMkO7Txb4VRFY5A0x26IcGFA
76kDlxoyxXW34r7L3vs9bC6aU2lXiRnDXI+qkHu07CZIk1a5tzK7fOD6NUaUK8FOC40UUIRcbhKW
lejlTvIkQHZMxa4wNrTYEdmuYw9l2n46rLEoLfrQmUHuDZZBhK22RCyn7gChD7kT7MU0t8eXFV/9
kaXlR8btxCq0kDeTYIg8j3/LwDiYn9mfNrJ7j96hcf0dzZ/716Nc2NPg5I+SI51WpnbxKDgbKb81
RXVIxgbuA0UXNDgPtnLT+6IPWN9TszF27oq5eR/8OHnOzPGbs9emqRtgbnBj1fktf96rd6WnxFCL
Olr3bvKprVhcW0luY5Zxo2WpANdh4U2nxo4WQDnTllC96ePH4ilJiH99iEvXPNhdlZkS3QDVKWdQ
kLqCCipWtC9vh96X8r/0NytWjCxP47cRbtNXSpSMUVFDbq6SM7+d9LdYZhKgf0NlXx/Oj5fqfzx0
7klUVVBqfpELnF1QObCPdYXjLQA+wZaM/eiHO+XY1idNR/PYe8W2I2jlEzsZxJVD9X9sjm/T3CiN
WtZyBS08gTnchfSzRt6lcWokJCq0GoqHGm331TtoXf8kraPWzxEAZOE7LdFeVD1o1otq+sk/1vng
p4M78bIMbBEWwXREiRC6WpW2fob3titYKnDyvXd99lengAt7irSHwJhR4DKrY5+pPeIS2tnUeou0
7r5B07sx7HXqIKc9/I0Tadeb20Hyk3Q7oVpXEEdG2Sd/UJRdC83M69+2vLO+V2f++Zlj1ABQMG1e
HQC55L3uDBn4+6xTdC+uMX3Nh8LPQ+O/lnheKK0xBk0v5knQGBDqIyNuDaDzirst36QzRcZ/PF3l
Dv1CtWKzhLBqYFkn2fDSY8dsNFhkrvmS7NfUX3/kGr8cyZSgsTnrhyIUu5w+IW6FJmo6XDGZJ1q3
4Ug3RfdUKMweUZKxTnSXsFNfO4fyw6wPY+tTYTe3BL1eX8VlD/v+Dv5u1a10aNGhhbsVXb+To/no
TgN1ANVH7Pa7TL/VE7cpa/SLu0MDpHFRO1MXeapxTOsHIdy2wh89s9XHlc+aHfvHmp99FrcYSTeV
CtUxPV0Xvwqmn9fbMd7S6g6PtZoWD2C+cCa93LNym1rvcvKadTaRHqtxM6KhL29VOw635ejnlUs1
sqPyTZQV7sSMgwLqdHP0wCz0r47Ks2+e79qzHdFTlaa5POD5cCp+0yB9AJHSZgDDgfoSP6SBsNas
s3gLnNnj7m6KjnEVPO5JUIXR5I+1OdgQ1mZOY/TR7vp6/Cjozu6K01/E3Y17AEnLy7HRjDXgF8fm
yJXITorMIVm0E7tHxXJLqELHIJNpn5TJ1xtnMjs7zJ7GyJZGG9iEGsG+0dhZtOK6P/A1/DdxZ3FJ
ZE0omwrzbQqbenoFFYdDEuIWwuQrzXtKTbvsfotiu3L7Lt6J55PBncq9Ik9q1WDPxNGhyAMFdWaF
3Bkg+pjuCojvdU6470u3NI5krctj6b19bpo7Nsq+UoxkgulSFF6wFEISHbNSsuNfppyunPBL5+6Z
ra/5P/NnvWRQOMdfASskWxWBWFvbMrPX8Lv83AK3y1U1keq4xQpm0Myio7zLKhA1FbIjGmucAYtP
NCT40ScNOC7E9jhbEdHHUhYxmjr3ZjCE8Mdwyk3pDDfdzRp8e9k1z4xxR8E0ofu06noYEz2FOj2A
+EZ5KL0QZY603QrTL7TrrAQLP6APX/vhzCh3Hgi6MrFawZkpd5k9lo7WbBkQ/SDhNCFkiKZnZDJM
FE+KB0N4rrOVXbF0Gp3P7+xNZ96SDzU15BqnX4h+r02EnJBrDSrurR7h/cppNE/fD785G+n8LWe2
4jJneRHPUVhx0NGdKN5IIkOfyo05VwaOXU+ciN0VvrkWiszb65ph7hiUBmOY0hGGY2M7KH8rpDAs
B70JTQgynQ/j6fo4ly7B8ynlDjj072isxMs3IPkturq8pAUTu/I77JApiiZEwysbfnl0Olqd0CA7
o1cup7UbBFmI0Igb5Dut2k3gZFDRfLzJGtcMFLaai5133M/J/DbH+WukpHXWmxieRY8lgEg30qPh
oMqJeMJSXWSh195miwcaMojoO0GhH7n0y/ExlrcZC00YjAXAUHsy2ZOGJML1VVsqgIBy5NsMdz2g
GC9LGsG9nNC7WLEldNtXd227xwa11cHuNagp+YrggSSlGGNbkR1jTWzoR2316yw4+wbungAfJZ20
BN/Qi162UQ6SBAQMysdl/cI+lHs076W3VHoyy30NcqIGmOfrk/ADc3/5ASjpXc51FKNDjrYSLmdx
n+b76NRBY9w8oW3PzDZV6avptkkf0/5oPhQvabmxoNNNE9scoTgkJ5uZr7GW70n12puPSTZurn/e
yhoBIH35eTkF0DC08HmZuKGJ37W3cbNpm7cp9XOwmZr+FD4I6bERu50oTG4ydZC4XWNMXNzf/10k
QA8uP2IKB7XrZR3ps40VuyCI6h6CNdD54r2nSCbwPfBIMDRyTk9lua3Qy0gC6wBZM4fIwNWQj8w4
5s3vhLXocgAPi+lp3evKFC8d0ueGuW0w9aliKP1IgjB9buO/2dOtoNt7VDSj8UNI7Pbt4brBpWBC
kWVAZ1GOUHDRX85m2YxxVuU1zg0t2YzNHUBuNfSjymQt7l46Rs4NcQMjdGqgoVWh1ohW4pKAZd18
vj6UJcc4t8Dt3rADrV9TYyipVjoy9B2n/pjSuz55q3Jf67qVzbpoDtIbKM0jYyV9Fe3PrtNMIir0
F7FSjVQ5VZm7IWh80TXqhoaWOEWrSmBJYSvxwuIRBQZ0iLVAwmKuVl2uVyIJBrpZUYpr3OZdCAoQ
J4YuGF/tblu56YfiOXLnbKf761O7GJqdmeXlgNKhnMSpgtkWuXmb3UW/lUfRn36LL8K/CW/PTXGH
jESyvNd7FMcSEGPp3UEx3CZ60K2VMOF/DMlEphi1HPR1ceFQZoxqNypzujptRbxAgIMnMilOjLAj
qLjYA6TFRjurKuuoSLS5V1Mt2V2f1nlz8Xf53LD4/z6BC4ys2lQEkE8ngSG5KtBScbvrACjJzYOg
rnjr0vZTscNRDUf5GMQhl37Tis2QixXSQZFZmfusZGBQgDO51we0mKABugw4WQmwUlPjdrlRdwUu
crxNoEvXRfu+esa+U6a/1WfePerqg9SCYvNj0vzkLRTd3tqGpdffmW/XP2NpsOdfwW0SqB+0Ql3j
vRdFor7RixJq7yJErK9bWcx9AaBugfbDmlmTuDmdWr0L6wTBO43BHyo4Qyd76EEQivsQWQUNLGTm
jXjsmo9hNbv3o395jhTObXOu00xDbzALYaA+3OWE7MNG2LdFtsuGkyzuO3GuSiboU36Vy3cCRvJR
8tPuiI4PwnZd/TZqbpdsNWlXFz78343CP0KZ7FIp2aokc6JM2CUD+kq7tRBCXnB5eIYCrweECx5y
6Ye6TnPWjIiW+8yLmrdCvAGf2FYA5Ci0p+c43RHkQ1npGyuXw/x7+a0GigkDYBBQdoCN6NJuM1lW
LSJGCiA8A4gNtZQDiIyrzSgo+soZveh9Z6bmKTi7GHTaI93cTyjXWE3rxU05bUtJerrufLMLXxsP
9wzozBBiN42IZ2spbdN9zNDcDdnLOAqDMPoT9qZnRGvgrMWo6HwS55GfjayrQgCXMiyeKYF3NQQ3
c56AAx/PVXD9RGgaiMGToE9HtMeLyT8lrJo9HqDeGacEwDp6vC+NU13KO0jeIDYehtaTCy33hRSS
q2mi5//iXEbUBz6umQMM6N1LU4IoKYXVWHOqKgMzf7sHvhuAY0/sdC/KVyKwJc8EagJ1cFCwiCjU
XhpDhrXSxyROAyUEbhywnhFEtTUII3Jw4F13mjVT3Lmo5iMALVmWBhUI4DcpnsNemkbEFzNzLZmz
eECdDYvv5xDbVAjlRKeBWDKqeI3J0AAVgci19RnppgqtblKfjXtBQy7LEXtFLe2e9OFd3U+S5qUo
FRKv1GUC9uokTKVdNhlRe2gseZBdmST4c6TkoIZre0PIHoyoIOyvJMYV8og6+FLHUEug05AzfTyY
Pcg6wd4/1NWWiWXNnK4Twaw+jTEIurCNID67MtVLeSUwyaNtehZlA8c9N9fWmFFSyUqKiKny3iao
VX7WDrHfIwdCa85a1nHp4kVUiCcZANBoBuAB0NWUUmz4hgbM/JB0tjdwJ4VqGANRIQZCgT4O9E4J
SD3T6diO+Q0II9T0Cfp4fq98DkIQah8WqT+u+9tCiKzM8GBJ00GKhYP30rVzq6egYYmyQI2ZLQui
nYu5r9PRs0ofrUD2KhnV0gkFizgf0LuLHClPNofAsaxHgWRB4zeSnYNB3LE/lT/TqQ2yeG2J58/n
zmAAKxCLgxYNErS8/lHSAiHbWzCGKzXINm0FYUy6h8BMsl9TeVnYuRemuBOpiGFL7uZxUVzPsWl8
xmX8R5OytaNv0ZHOBzV/ydkZrwFiLMkmLI37HszhxQaViHA8KUXhhsK2EG4gKIvHsOaFmY2+fvFF
67fg+k3K03Xf+R8f8tXZD3w5JDwuPyQz89IoswokiOxmkD2Ak6k4QHiA+Cf5F3usKi9/iHI3AeBd
BBcqecxlOx7Qqv54/UMWgvQZPmOBYeDrO+TL72BGNSWVUGRBljVQmHal6oACMaAl0Zpi5byIP/3p
2xJ3p+tlrve9BUu5Tx6KNa6EpWrUxUA4HzIiMo55iAklo2MUbsI2SfqUUHs85J/VG8i1uk9wzSeO
+DJu0Vd122Ph12Lmpcop3iC6CCj9V6sEdyw2VI0VtJzBvcJ7ttPN27J1BlesbVCJslcGve7+vXmO
hn2O1gbFK9r7qrPBeo++s9/5Ku334rYCoA8MQDimgBq6XNssnyCLUuFr2v1AS/SyvnbCITNRiBrL
bSMcgAmItVdVvxvaxs86KFkJZK/FayQf88L+WHjQyEBhdiZK5vGgzZRCGUfpsuBZUv9MeWGbJvqW
wUOr2VniQjQhlAJVeE3VP72ydlEtroj+xWoMyhUwCHIrMlRhxUxzgH8/to+qt1N301sF7epsZzx0
3snaNI74ZrnibbGtD+0KyHHJ5b+N/0h4inHH8lKdsqA0UyAV6kMGeP/1/bv0TEPEiN5WBFcSsmfc
U0mjY20QdG8G47RHoyNV/RrFjmOsO2hnOFmQ9jQ8pjnXrX5lRPg1PbfKJda0WmGMifPIZi1YL3cJ
OAL95k510Dcy2K2b3gt7xXvdNXfacXja5I/d7XAbb7W/hYsK8ONa49BXPuPaB3FxZoye29os8EGa
Le/rP6X/Fjsguv+4AYPOrnNbTwusbe+En9X2oThABMJmB+HxvXYNL9pYJ9MFVmDXbKMbar8inttI
+P8m29i0T5AzX5m9r3aHax/LOWVTVE0kd/hYCgUipNUeiO7QoHEEV37xpEfNm+VXxZcWYrTb6wv3
M2YBkhnB/4zMRtGTz3HLdWUkqjqygApQ0BRT24KKW2S3OJ6QZQuR9L1ubx7J5UiNmdQbeRn8jYYF
zk9KJc27ipVNYKKBzu5274BosufMXcu/LuS7wFeFOq6CFxT01PlDRutVM0tICkNkFwNg0D5a8rFH
n5wBThUBShitPWor2PB5a/GDM9AwPWcrQW3NkzjXVhdVBQj2AjXRDlLSeroVf7BO8Tu5/Ht9Hn+e
JAZoB9GGKMEamoc49w6HTCUmoFVBVItHdNDhJUVWkhc/I4FLE5xTmkmfl/pYNYHRDz6tS9T4tlXl
ElMCRmblTlgZDt8PlI+p3moEtoZGfYxo6ivhGgp6zQQXYImlnhRSOw9nZLYWaXYSvVxfk597CYuP
p7oyS+5CTYmzENdhUXUaxZqUIICDtqVbx6Y7kcLVaOElVf/XEtkKX9CaTe5KB95GFcMwa4IsTBxF
r3ajGdl5do/zxG47YG3U7fVBLk0j5M/EmToBPcf8kyNREiNXc0yjNo26NxroQGO6+Ou6kYVLbJ7K
byvcMdFHTKWVBPcGCdBpsqGDdXwJW3vaOxpxh5V0//Icfhubf372BiBNXkyalTfB6IyjTf5Yv5sR
LezP18f0M/i6HBK3nTKLgYQ+hJXBj5/i57UbeGm3fs/YD+Y0qccqRA3OHg2dv8IUaNAWmsIAnRqt
unJdLR1z56Y4P+/TEoCzaT7D6/cSyrA19cG/Wf4rKxBQhEga2gT55yZIIeKaEFiZBsHNIM0uKdBF
S96a1lwJmZbH821pdvmz9besOBkKuWmCIreggSlHj0TKD8AdPQvVGqHCohcYaFICmwKEb3Tl0pbW
NEOaaCN8rYrcPAYaT3qbEJRd97Xl/YPIWhYlILJR1b000wNDX0oTzMTsJqoBypahjGXlu9IkthF7
shHdxqHiFJHySysn6HANr9e/YHGcc3gNIgBQVPIk6iTK0D2fi01A09fCwjDpMYrX4MVrRriNq7eF
zjJwMgSxJfhxHx+o0N9nAlk5YxeekiaUf0AyOyP2kd/hTqMwsoTWUEM4SPYZIrMkmiAYoA7UbCAk
YzcpmAamT7kvUPsBD9HgJV3mtQXqEUVyp6WFI+MJWpGncoq312d5IXC8/DJuBoBWqUjLDFw5eES6
AnPDRwag+99w8rJbY9tLQAW7xsm41SBp+GEGJqjbNDVYe9f8PHzwGaip4407C3LyDQ0tWHzMcOjQ
3JdaTizfD7J0oNkeXDaavlp0m6+0yyhrzlSDeACg6LmayI1ZEMAPWqtlO6OR0Rg/ZjuW/iksT/sd
VX/wxrWB9BSyTyET/vHrDagnaAbNHLoyZBu5E9wE8bsQGWhhjI3fmn5g6dv11VyIWWHAQFFBRTkP
bcrzyM8OItaqU0HVpAuauodCpVWmonTTpaj0H7PWtMgGf7beJMFsFRB6mZNh62llbKGWo+ru9W/5
ubXQAY5a3/wmQHcoXwEX0ylKzTAeAiSpJeL2UgrS4FEHC45sqmvsez8PYBiTZYSpeBRIQLtfjrsV
MimSq3wIBEp3ajbWTinhzBiSAW/HfC10XhyaAmpLFeUV1DL53TxMRWuC6CcAzEXcj3qo3w6gvt+B
iyFZiSwWTYFlCiruyM9CGOpyYCGBpGeudhjYaIGAGminrawVykEJ0Wx4fcEW5xAUGZDIwCsOzA2X
pphJuioO5SFICgIiYHkbp6WGRojBa7Vx8q4bW0j3W7hYkKUEFGTuhuDmEJX3HtF0OQbiIFj3VqTX
nV1oEY0dCVt2ciJjLNN77GMKYo4I8rxZY7A9qQz6VrYd3nxGEdLBzg2pe2r6jGbP1z9w9pjLMwLf
h/wO3pqyOOfHudlo22LK0RIYhAAPHzJDzefOLnllGn7O+azdCtVuPJ6BhDS5y9yAJLhQKcIYVGjo
OqALf9zrghDvmqImT6LaVyuNnAujwuqCCAUYHLRRc6+k6zP00zXx7We/i5shJIjkUI/UMdAflLd0
p79c//ULpYnL38+dZbqM2qxA8Pvl2El/p4c42FkQlAUL+imj879X7P28gi7tcWsBmWSlTSFLAtzm
kTYHWm+kl0T/PbDNAKyoqT4Ogic1trgrk9hBkc7uhwcWf4DkfmUjLiD/L79kXsWzU3wqdS0qBwXd
tZGntAf9j17eyEjHVX8Sv8odMddsurHauz8rMzCjJTmfv1hR7gQAQTjYYzXYba1fZeWydFtPfhaC
tjR6id7p5rq5Jd9H5+IMk4VwPa7Dy1EqHVReszqfApLKqL4XZAS2OryzCMhpOrlgK6+BRX+CHAow
+WgvAcsFt76kbuiI63EKWkV2dfIJUv/qKdy9TtK2hQIe9YjpXx/h0m7TQYSiIOrDhc8rLIyWVBOl
Fyc8C/TaT8Sk9EejWUtUzdEKv2rnVrh5rKgVh0PfTYHJCodJ4aaAhMANev7t8GBayUoou7RLdKjX
iNCugXgOXwGgDc0TqbSmAFKe2a2IdwLEB4xqJwm1sqnVIuiSpNj9i3k8s8mtXCexvschDZtilwAk
BCb1rCrMlVB4cbWgq47CJKQD9B89aoi1G6MhqP7KanNDzelXD6zSipElp8e7BfotMycVAt5Lpx9S
cOO3IkrMcjNEN5Fk+GAkeqSGmbsj0dSViVs6onFCA2+FFxzYvufFPDtIkL4UirDMxGDCFWf3Ztu8
Y5rzWy1vq5WbbCH0nDm2QPYNtgfIsJrccR116qTWoTkFgD0qu2EA5/WQ1iD5s8zRyVMxeu4a1B2N
vixuK0bHvdFb+kq0tDi7qJ0rM+8UQhluK8yNKZLRI3cxIW+6T1KzsYnSjm6KzIkTT+bHv/BLkGvh
fQqElsGr302pnA1GWIiB0Q21DxU60TYZ6Gv/uRX0ERhAKQCqICvca0XLBLnS+lgMCqN/yFMIgrRW
+/j/Z4ObuMpqBYNQ+H6aCZJNuiaCguBaLXOhQg0MG6IcDSciMtw6NxIjNXJTyQZYQQZ/j27b+mCY
o7ULh7F5bEUk5lKztjwWQcWPqgz40mjUbSmMRq8C0NvTiGD5fd0zW6rGyW0FnTxFpUqdmI7kH+pr
Qsxx5oBBTQPtiNAh4O5ClNKr3MpkEfjPMHRTXE9B14DwqU1oGlyf/KVdCoF1ELRBm27mFr3cpQLo
46M6tUQQxLejI9O4OxW1qdraCCTIdVNLZxyqlpBFQTswKnxczDZoGiG0VuBLYhvdTkkyQUC+Ef+N
N51Z4Y6ChmWKQXBiB7LZqhA4LoudTts1IsXFaYPOpQoMz5wO43zWlOnQpXokBWC2GDdJB+wgVN2S
W6Sk9JUtuNDIAW/4tqXNkdPZQVqqAOEkgikGGTIKqACZLO+O0jAW/TYCvWB77EaigN6unjrmKhb0
W7YKsURoCRlTjZI91VqkyKiq2yLR6shumIbW50JNVqnXlmcFwpFQBEHWjn+btmLRCo0UimiQS8s9
2Ea1X6PY1w9hW1grJZd5gvnAw5wFdub3CxDSnN8CEmeUjZVKQDfKp2HS3lglP8ZaEEloAEH0PGNL
mpWQaml4IJua7xhLwa7kXIvF6lQNNWz2rIxtQatapxTi2Ad4IloxtRTpmCDT0uaTAGLnyuWajwgH
OqkopSBOcpscGt0dQg9cfqxfiQmWNuW5ofnnZ84VhmEqJ2YxO3J+DzVVh0bZSuJp4WLE9QTgBvJd
kCj5Ek84M9Gr81N79oqojvZ5U28SsHvYWp8B2HK6fsQsxdmo0OLIBJMOCDd5SZqxY7E1dBiO2MZg
NI46V29i1ScDG25NlQlOQ4r+2DAVlX3NvNFbc3zJBKVcmdWFzo8vHW34CsBQaBHigp+Sonc6GhIJ
MAndjqCzMajozZefGeQe0WHgVHu1AcFPJLt9iRf+qN/WtPVa2t1lRbETcihmXJ+Zhf0yC3v/94O4
669khSX08rxfYkdXiS/T4hBiFtoR6tT9aFfjUV0DAS/4FmyCEA78y5AL5MN1cyhVMSY1bEaZqyb3
Yr7WK748qm8L3DYZ8OSyGgYLKotDn6KiZw0B9LVOrGNIZpCHcgiPldWvvEOWEkgXI+N2zYS0bklZ
IwVj/qGnL8JtZCGDNI1PiahuioTYReOWI3EspfLQUXubFjaxVhQbFqokmFxTRtcbyHRBWsD5WD79
H2fXtdu4smy/iABzeG1GBVuWRMcXwp6xmXPm199FH+BsqcUjYl8YGGAGAxc7VVdXrVorQ0zNwEcA
lSUAp1IwvR4rkp71HMCa0MAeMm8byY3lcYNMskjYCwNn3t9W87ah3PDVN1DbSqlxo2gj7sGqj9tP
loEMCsm6rn0dOkRKk+gN+z7ueGNKs3rFRS66lYvhU1ew3KsZF87DV9CNwKh/EL3qovI1JWvJ5GWn
8o8l+gIuqzLyAVmGjzwnUFOJCPOI5HX0Urr9Qfxa401ZuGUwpWDFQvlJQLBE3zJeGAZdVHFnudmL
wpmpLXFcycQt3C5XJqhj03V8kox9Ce8k/8GIwDLIp59+r+I629zfH8uL9M9gqIPSpL3UyzIOSjrp
QAg5Enitczk/JIN939BSfH81pnlaL24ZxJxj4bNwBS3ysyX471NLrkVdEL951CmZoDc4Tmci4WmK
U2tQ7aLD4oVGJY7W2MmvYip8SyH79/5XLfqni7Wcp+fiozi8zThIUc5RynsQQlULykzTtg8/auaQ
cQchON+3t/QQRp0eKVawDyO/9XsvXRjM2iiMkKNA3NCRCntVAEvCp/w35YkKpFJxqtdgsMte6MIi
5YXSfGLHYZ73OvDMooRi5KTZRXwMR98Wmc883vctbxc5m5O6e5GaFVe8eMdcmKccUJuWYyB77Qy5
1Co7UDloh/vQLlyZ18VDqQGzBAHcGQ9L7WMlH0CYB72Ys6zq/PNGxOmfQNG1h7j2QwJyDX3tGbN4
RC8MUtu5YfoQlTIcHLGbyDiLeKi8yXDvaREYzfR2f3hro6O2qd82RThpWMMiLz7qNsl0NeI4kiZJ
rN+3tHggLoZF7ZZeGZV+HGBpkhozlY6xalaCU8t76F0WxaQjGbVicdEDXVikNoiW9hBmVmBR6TJb
9Zyxe6tTNM111v2Rzb/n5ia8sENdR2LFc4n0u2DgOQ/OfWSzjUh8ETLXYWlwabsS0K2sGZ0xRGN9
FDcSxjXIm1qpiOhlZGJXQvc1I9STPeXy0BtD7EK+10wgcWKICnrs8/2Z+x8u5L+Hi87e8UwwRv0c
TbHH+jMzSvvk/a2cP9FjGeve6b6xhe2AYr/Az3kzvNzpx0jaa0LrqSx3zqtK2mvonzh5ucR+BUMV
GX6v/Vs1GqRyZowDGsbw9tEAXb++AcRIUJughL1OsUdpN4BniOEza2QU5/7Allz/lSUqbug1Nq+Q
fuTAGGPKyabU0FKTPUSGWL7XyQFAN+SxV/bgwmlGBnIeIlqGFDy4qMHJGjfkwgi/kU39hq2K5ASI
eGZpeNWaTctOJwniwujLFkVI8w3imiTcUmQGRmZoJ2NuZSgSzfv34rrj/SBqkG5CePES/S1rMrjS
Y/+WPrH75jFbe0ItHIYrY5SXZLqkkXNYO9dhAeh7ZSZNDMhdY64s5JodalZTTckLIYcdoCgMKfAP
bakavjptS2FbNJweg/pNSiWGoD33UPTaRo3jLRvEdoznJDeudQEvLvLFHFMONA0Ezg96CcP2J9cX
t1w+PYRxiSZlYRcmol5nrMlE9cosLJ7TC6uUO43iEGWrHFb7pLUa2bc8sC2Be85qunHF1Mp8/x6s
i000MHmkKT02UcOFkCKZ3pT6cRLBdbayrnNUTd0Ql/vndzNf2Om6qFd5PNBBJ/mTKm9dlWxbTiUT
l4NSGDFrwjgBrgzUmqwclAJIyutyvKaFvLKav7744iOkOu9ylEu4M5MWJOylrTpUj2Ik76SmA9ln
u0mSymyEtTle8vEYPBAXKmpPqP7Pi3Bh1y9jEVl+Bq7ifWgIStkdmfRtZ2fHIiY9WaVmmf3q7WT/
Y486rGXUySWqU1jUQAVLIl7HIRqUgCcdikLHIYbSSk5SSdEHgdVrbY2HaSlpCxZ8HoigGUJ406yk
abHUlJ3KnbO2J9ABfuhB+8MK3eNUyyhv9DZgLUi+yLt62ot1fB4jETopjsxMpBVWgP2La37xLfPG
vJj7auCagYuw8YTE6iF4UoMe2FAggg1iaVDexf++EIahz+xaHHSYb9I+rM+USS1jqcfhvRT0frI4
kWTtSuB/Iz7ye7NemKFGVXNqnfVKzp+zpEbDWRqmRldUTQAev6ibpY1lxOpRj15ikEt4eioNBamb
ojcFNdcMKD3FW5C5eTZoSgez48f3UBnKnaLV3jZtU9Gc+KmBWEI+GWEtdo9+CsqF+x5h4e0yp15n
RQ/IRHAS5eN6JI0gHOTz59grD02Vn/1WXSNoWXJu4G2fYVUzLI9uzAzVqO0ULsIsyePohIKvbNSa
y3WUDteAyEvQEWTb0ToAajXkrOnm+By80zUXFvxZiYUPdPqje9ju+UceqjeSdo5D3kjYz6BEjjmu
oTud+3oG4OP9Ob15N0F8Ahlz5H4RDsyAvOu9jvaYyYMmcO2yUkFYcGmIoWd4wk8h+4bPrwSTNzE/
FGDmSgf6AFF6hvr2tTEmZEaRY7ra7eLizJT8MRxyyy+alhTstGGmAvue7Vn7/hBvfctsFkxGs7IB
st00utEvmX5KhaF262m01KazCwhdx0ccNNSAICn6VoFtjnX9xuy4zu5r8NzZorRGpfcr53HlYmf9
G4TSyDdwoHuj02JxHQX9qGq1O4XP0yET9CEkSWcrLVSnCYTtbJ8xlWzf/uR4KRe7UIbUq9kewYMX
SNtmdNgeql8BZ0NPo433Xk641GiHHZeQljnU5zVRlluSg/l7Ab0Fxz56ppE3vV6tQCmFOi692i02
ylf6HZqdDqZtc3I8o9mxT5Up4D6qHYhjWb3T7iHxce53jTEd2MfRWc0o3Dhl6mso98XkYsyoIWaP
t1uzNGu9NcF1qiNex8XokT/foxGRH8iH3t88C+dj1jyb5d+AUwCO9HoS0nYqfQ3Idhew2EHO9ZZ/
VSRMfQ6PCd9539itR5gr2FAaAx8h+EBQqLu2VtZj76FnoHajrnCUrHKz+B2EMWCzaOzG9/d5jG4s
TgIPSf/TMN+t+tonnLHyEfO6UvsUGXLgvND2D4qH32T+xfUXeQ3fMYVcuzGaSoC53whldPSPErqq
RYiVNmDT9UmpdaZX9goBaPlt5QMW3MSMNUPDLOrF7E03gRdmIatmYeOK0avXN6TPvyOf3whpRlqF
JUpxKOJgM7zU1aYvHorEd6oANPCCIflvIRfrBS+uRAS3BQwsDKq0AnhT8DaFFsz1wqAUJLVlKjSu
UHOkEvZAvDG+PSAahWhWroEJu/0JB1uOnkpo1alpYcYCv5JcuLn+8A0iCFvQHTOfBZpwQu5BcQqq
ytb185IjkTYKBNwfg74y+zeR4GwGpA/CrFUAjWJqx6MiOLIs17UutBFqX09jM1ZfQuFRKUHc6nq5
weZG2/5dsXq76SBrCS06LDu2nkRzEnZa1MZshIK0OkEV1hofx0EXoZYrSTsN7VkiS2QyDM60+pq5
PXNAxoGrCUKWeEtAtYh2LNEABrWSV88G41ibr9CMTQTcui7vVlzJ7QVAWaKuv4SXGomrYGm0i321
yYyBfGcEPYNEhLxqY4y6Bdpmq3E6PXA6M7RVA3VsnTNDI9hC5HTnW9PTmhzGL9z+6rhTX0W9NHJJ
aMEQwangchnBVhD9VbcZRIc7qyQcAU2ok1iJkevfBFLuZm30+GEN2WJs3lJsnoCdwo6twk5WMD03
/p76LOpBMkHEBoIrmKxe52BeMTNSEMZQ1rzdjbOh7FDbnatzDUICv3byF1bXMOjMcH3y5/WzIh5U
bT3CkpXdftvIMxuVJXCEAVYIAB61EzSW6VMpk9TzZPWYc8GRnMkJdW4bPY5GalR6pB8Y0hlbzKt9
/6TN46GWewagIgZh5xuG1pkEf13DD2GnnYPcVfmHkklIVL2HxUOCMux9UwtLiOIKWrJ53J1z2uva
afbgwgAjc8GAk4PkpT6wYCkifIG4BfkYA80l983Nk0aN7NIcTco0ccGErVwyZ4UPSBl9pfW/njrc
iWidhxQWHCNw0NfjkUrUz6uqC12hKYgg1UQtLChq6wggdM5vVxzx7UJxGjBBoCUGMRgQNNQBEBl0
8iEBAmsq0MFAgOTv/KsI4Yc1Yt5FQ7OzB7YbFwsd4iTi2OVZI4Qur5YESuOpWyB/VjrlmoDx7X7A
nKG/CGhCIHUwg9fz1yL3KSlMGLnKGXqFJBATM/caUjJ6gno/y5tDuTKHt49eDSBysDMhikFF82bJ
kOnLiyj2I7exRrN9+BK3o/7DkOiQ6iDssmO9M99Zo7FB+24HprayI29zzLN5gBtmSkAAQunskSo2
oKYUksiVnyFOYXhW4dSW3r7e3/i/SfjrnX9thrrCekioVhHU29wUmsQSQSOQWZJABzEXv6lAcAHp
i8fWqIzQSHSBvD8Xum+s3SM32uF4K1+NlTodCQIWwBvwEcWbD85DBsL2HZhAch3U+kQ0BvNpIqne
GxAotlUC55ro0gGsWStLvrSbL6ecus7kCN1lMospV8iIirGii+AGK3Zxdb4/6bf3Bp6Tc0SIFgVE
Y7QzqMVRlrO4iVwJiUE1C0itA3pHFO7Yb5K1t9jv25Be4Utr1KjKtgUOC3ycbv0Zm2CFtjSC7aRD
8lkHV7iVmphqqzA5MhiT8XVqnMmWSaeHdr6X9AoS5Q2p32XSblhS2ayNN5T+A6o2hzFA10Y0YzAa
g9ms1RJ/G49vPhsNwVBQBFRW1qjPDqKoq2JejNzOEoxut5mI7yikPU4Wb/JmTkad3QL5syntyPKP
p9bqLZnkG9YSEty9n6mRbYeBnEODeQrs/8f64XaCdwA7iarMAenFK2foG9wW4fxprUYi1WnayWhK
zgEF+8wPna4VqG8S9DgeAF+ivxKpJajRUvZ4NdZSpitjN6/lTQah0dzbyIyyZ9YSfbdFHsoS5Q2q
tsSjboAlIPgFyy+tsrU8ZZeUtmgwyC28sWs9H2tjo45+UGmFwGQFxtZOJAqe2uGxCweU+u8v2S1K
EE9S1AVZLBrSVuhBvl6zMI0zLo+ZyOUVo2p3aeL6CEanTSDEROhCyCwiHp12HeP0dnwGtKH4rtd8
+u1Y8Q1oIwWwFXl5BHHX38BOfSBxTBi78uhUysELd175wHNf/4+hglYEWTIFrzHA8q7NDPyAlzcb
x+5gaQfhvTTTn+IJdFmb2FRsqHiYCQFCpFxJRS/O8D9mbxIQPSCpfj7CbLNvbfGYH2ujtTRz2raQ
ACy2igHPc+BXBnvrshEg4hQCuo8EGYA412NNEuhwx/wQuwFjeQ/iYx07I8jZSm4FA/3bK37tjnD2
4I1mkiANDQPUPmVDvHsBekrcaV8f3xRSEgT6oRlZEwihTvbTfv9qfz99f3tv/SE+MAXp1hoXF4aK
3DL6yZG/1hBzUcuaploEuogyc70PMLx+cma8ehHf8hfMGspoYwNjpoA+BTrsHgsOsujVkLnjVnxp
PwLwmQNfYYOI+DT+bcz+7L3CsT7ELMkLY63lbOE5DevAzSLNC03eG2bDqheatIQyr1sYwx5VgZ1v
v3K6SjLc9ED+rL2p54wYvaSX5ii3yo1xl8SSDHOb1EmPA6enOrvRHqudvEmM2BGM8ll6rK3GBNeb
HZ6zZ831TNZpXxVISzwy78nzWiS0OgXUfma1MGIKbf4mgzULS9ZLO7Akszd4I7e8x2zlJrsNq69n
nNrVRdGFFSQBM5cBqdekHoXkQRoPYqtr1fMsNxsZ933T7OHuTTnlAQumUwZJhD3We+S7xBDKXSiu
NUrOH00ZUdClgO4BFBeRDaXWNZT9UVAqNnDr6ovlXou1NNfCIECWh7ANkuN4BNOU8V2m5R36XANX
Uv4OzROT2SEYh+5P1MJhR9SPaqaKk47++TmEvAwxpBRyR3IeuQcQOJgnqNP+67Qk3haXFih3grRk
xngFLHD+KR8SokZPXPLAjnYu/VV5K3dFfyfupU+tS3XUcO8P7xZCemX95rJARSrlebReuCK4OPT+
Jf6WrGmXfPWG/0AEZ4xMcRMWm+JZIHK0YnzhGsas8hoL3sMZZEhlysUsE1oBQGM3TUmPx45THeVm
Zf3oPYgQA7l4GAGBJOg5JOoc11Mf1nLu564PavlYQkNEsDKKG19Nm6DObtZ6SuOnMJHt+x/mD4bz
Ur7wn+k2OId4K0nbGMzxP8lj+tS77IrvvMEY/Mc4mOoxkxgjnWHoqr7Koa4D466wK14DPTjL+8Rk
nnAYArJ2M9AnjrY2n5aL0xDnQ1kMs7V8Soyh2ScB0hrdy/09Sb/KZiOIskHKDHwVSCEo3xR12lS2
IpvD9aqyVT7HqT4AD7rrV3LxNy972tC8Py9GU/ZNmhbllLsCCIR1iP49JztuWzyqztoVt2qKmjh5
YguVnzAmZuc9FJvk4Nv+PjiBmHIlvl5aocvJo/xVqcVwuzIMKRJe7N7fUt5E8cpltbjpUNoRUQVG
AKTQKRFOZoTY47jc7beiiS3QfRWv2nPkJM/KE/SE15qpbl5DWCgkOwV0BAoCEncitVAVWp+KOSRx
hQMoKPtTfVQPiDR3wk94WHNKC7vvyha1Us3EtH7AJKUb78JtQzyntNrXNQT5/Esub0Z6QNQqBbI6
gAoTRoJN8iQ47IHfr225xXHMdP2Q4EESUqTGEXpdzMfAprvTn/5TeAy+hIrwr97n/bN6Q86LkeCK
R4kZfWczSyjlw3kpTiBmkZdu8ga5793JtqxhRxApPnrkVT86UIRy7ptcmDtYBIgE3m6u51LuIdXQ
deOzdemmJ78k/KGxse1WmkUWThHy+hJeMthskOSgspx+xsRlzjCVCzanKNEIC/C0769cHEtGkLEF
vh7oDbAzUhd/LCQp1xVB7YbcJgI6LA5scBX86/sPz6U5e49iIF5MIrXTpESrSnRWAxuiQE80SmQG
yk9JYt5fk9tb9toKNRS2ZbI+Z2FFDMDmkJMcNFD3LdwAQDBNGMjcFYzSBx5E1EUu5WoY1R5MtNx2
EtF2pVkyr8sy0lFPEAcfrUbvcl3ztxDkLVH8yla2xOIQZyo57D08i+iaCxfLsST4ae0OXaORVClT
va1Gbm2Yy2aAqQe0GLVUGucCrQlvHH3AayrOYCUI5+mQb846na8JIJL8Gxt/dNNHWxtBZ3BrjJR0
QDbPMVA2s2MH0RCAhNcX4sSAdon3gM8oxsqR2FdPjsyRf6mjtV15u/WvDVEhEwcIG+DvSu02GarT
Ike64klau6ZuqqL0cOavuLjfGYnL5SAHCEIiCvmy6ofhy//Oah25OwcoJdQEQ6OwHaUng1UZR55s
A9ISyZiz7z4S7WfI6K2s79LyzrRpc2soeL/oQnUw5VKagiXVBeN3cAKbm2ZMU1CvuMibksnvyIHo
xyUCnmgw3F6PXJnGKVBVpkExQd1yu/RkWKyeWdxOQeYJGNTEkXeo+fKGrm1WoqpfANj13Ya1vbBN
+c627FjAYWE7J8zrA4rRemGASH/bHWoLGWEr33zmVmq8sIZqJeb5730/cVNHoYfOXw896QqBa32/
dQHBtNDydpCQImLtYuMlBDl2S7IHR9F7C0WME78fHrPtWtX7BiNAfwJ9jPp06FkBM+Cret58Ka9D
vfWUtyawlNdI1LkAj7zaAq9IzdkZM4GlWTMFg83+jkIJoMweEmSyku/DmDHyOtLBMgRKxlTDv06n
1rfz4VsaO9Lzeps7Gmvdn8CFUBWpCKDQcSnNGiU0EZvURyCmboEd8Qs9LPa1b8qQDHPq1+xB269d
5kvnATcfypazahJ8z/VqFS0UfkuGbV22/ezEmHB9aNwfz5JPQ1iCwgVwN2hko2JHKIeLyhDFrRvU
UbIdmjzbVJla6WyraSDH4coVewvBKqBfwN8A/YVeG46G3NVjrCRMkrZ4vkjkITpLD84ZkLaf+8P6
rTXQx+zSDL3JlETJmAhmQMWx57fSWfrD7SzrgTPkp8rx9rb0QWxCTh05bTQz+jSZzfHIkuDjCBp1
ci70kfysDF2Yz9a9b5pX+8LhslUNVuYW3wSujVjdRQqgZSc2sDRUMVBNRCbxmD6jqlW4ENhr37KY
5CjUkF4xSmcMDLE2m2ch2nE/DXTfeGg68KCq3nujEazlv24qnfMZvZw+6m6o0roBLUPSuny8q7sH
odAdTIhvZbpm6D3pd/gb+NFIZEZmZev8yTgm3MpR+0Uz3Jsvam/yQ8cyvJe3bp/aY2wDmJ6zX8Br
+ZWuOYx2rKWtlh7T/lBCyEDod0mxCdmvQk7QM0hQL0FPn8C8TaoePyiVocnGqJ064N1jU8SDWdz2
vJX2OtP/FJuqJ1xGOMau4kMemwNUpWKTgz5u8Th4T1FN+qKG8INM8B+TGkorMfSC9mphTrIlbMI/
kR/uVDBYQKVq8FYuxd9sNjUPIFBB4QA9Vb+sS9f7ptbqLpjktnbfPg5fAM0wpNmUJHtiyBf0glF6
nsvPyO4z5kB8MzLmnxwC3T7+kQGo6PFxa25Zsv1MnGfBZAn4fsk5MAOAriBWqf/np3cyHWfg/jFc
Ou0zzwNySwhLIXBF33ZVlYKTakRYqGwSlv0Tyu2D+Bp9Kowja1ZWNa7avkSrMqvzzriZMZEHkgWh
MMJRavsKeZh4M2GK20vola2n8kOMtDc28h+0cGJXzvXSlaAIAE+itAJXCuzH9fpAJTbMWnnG7QoJ
iDvcWqqNghUNBZlp+S0SDmlH6lUd5aVI4sosdTxKoWQrfoYLa4cXjRRPYkmScwzRadnogVsTTE7n
CbNhDQ5pNmZT7zK7dIKVhMpNJQCeAuWcOcE842uwQa8H3ythITIdIJuQrQyJplp85BvNMyhEoV2G
XnPOxAPxIBb2/Z01/1p6hdFRIALar4HAi86CQcQwFSsWcQwjPeS8D9nsNczQ8sguTFDzywQlclKD
17glZxdYyiADD2Rgd74VM9tCzwuEv/1XZ/v9y/2xLWQNMKcXlqnkhFxEvJYGGBweMVa1YU20MZLv
jvz5A3wDlpPTK1xSvqHhZw2HcVMf/V3QC+NUzMGLfja1QQBw7IO47dDHCZ/ibwP4FODh+Tf0Zg12
CeLIFS93Axik7VKP5F7xKl9lMN21WQGqAU4anQNkMN5LQMGDhhxE9iS3smNsaAC+8CuF0xv4M2We
fhNoqed3uQDzzK7YM4/Ko3YaXpVH5WGw2y/tKXhYS9v9j1VGChdwazSK0CjkCgI5MgiBWtcbSPoS
n4pzYE2Opud/Agw+IJCrYd4F91ybMy+74T2uSdcsJCrnffbPF1BLDQk/SNKJWOpCMJVE9+waaXgn
ZndpBNUA4h3Y0mT7v/d390JBYLaqoXY6d9txNJGVyrBeJtQIg7g/w0ZGP6tPxA/WFAUr9Ddo72af
uHGv4nF5FhO3rYGI5fUmXlnv2Sff+o9/PoJ2W7WUsIGMyVeTtjcD0DTqfSjkeicXr/fHu+ipZkJG
vBVU0BxTljR/0Pi8kNBeAUr9/IGtGv2+gXmVboZyYYC6fjShaJVIYRt32DNvkiPhIbSbnuWVCVu8
5cAR+t9xUO6Qm6oMyvZc48Y/wh/mLf6GptRePJeHLF8Z0PK+vDBF+b9pzIopFGBqagn/MeEoPICI
uwRceMfuhwetJ837/Tn8VTygJxHMXLOQOLKakAu8vsYUduKgVYjjX4Skegdu6T3dStK2N4YXUDuD
GNJNX/2MyPWK21u8ZS4Ma1QuQqxZBmGFhk4QPMKrvWxrb9qufODwJPhJrfBpTWl0ye3MKayZ9RL0
a4BnX480ytCFmvF48TXlAx7VgVzZUvRcic9VOTnNYOaoLJVESwBaBVk964ARrMoEEqAxKN9WqQfy
1MzJMyuv15Z9fpNRa3D1ZdSyt30lcN6IR4cYOXy5k9B90j0F/HsWG+L06DFW+d48TNsk+rq/+PPa
Xtnl0DcHEPJM5IJY9Te3evEuq9Sgb1qEUxApszQA/WUdl+CpHZ9KrzK53kNH/xpu/DZfC0zlTIKL
FQAZEBJC16sQ+rWIwnlRHwPm4I9HT2OMQTxkDRA71XZ8hbidIO/z1hJ6giQYCCXZ9vv+qG+zYPgE
wALQ+SZDOhFgr+tPyAs1CEKtqY+tgrZjwjT6yH4kfGMGOWtxEqPLCt5aj+G4ScqNEhhl+sQzP9MI
SrOuPGh2Vv31GSKoesusLMiNR5u/DB1IUExCN6FAV6VBBNNW6Butj0IdGJ24L5mfpnb78a2RNUfA
dXl/Jm7ugtmcLLJgtZUQBvyemIv1b3LQ/fECSCmhwK2LwU4bQl2un+4buT3olBWemm7wXCUjJIyP
ffqjNB1pGsXQutKoWWSQ2FMcWxHvZF6ql62TTc9DGK6cr+UFvxjnfP4uxgn+Q0ny0f58hGBzFGS2
wjQQ8cp0hRk39ZQbXKiLcUEgIprG7+9DuRfjj6Z5BqWM6QWGl29FBTqf0RN6zzg/c+7Pz+IiIBmL
DQkydJaOv3Jo64RyNNXHCRCE1ncGr9aTbvPvjSDZhaYvgOVZsA5cz0CrqmHVKF597FTmq4a+gRMr
UwKyVm2N2uE2y4nllgXU6CFYNCuDUi/fWmiDpi245tixzYcceqY/PEwhUMqizfu1DjaJufNIcLLU
qIVT156EYSu1TvhU7iIP3VNps5+Sc8BbAdoIPkI9Mnv0w4KQvis3eWfnCunB+1HqZbmG2FjcJ3No
NgNAOQEyQdezlA+xrE6a0hxjhtvFvWQyfUfGYDyFaG4Rc1FP1Sem/vGwUEGN0FT5wjuc1OFTHwJZ
PIshJBb/1uJ90hRGIrIGg119fyFvQwRMLwhwVQVNPqjE/CawLvayOI5RmUp9cyx7I+CAgsuzPbrI
wYhakfKs/AWEczTu21y4Jq5MUv6y4SJfkiuYDPQufWiBN2KGkzAeOzxUss9+tV9w3ozUtQT5ISBx
UQtBLyRd6wrhIJFx8ttj+9M0aI6Hfs4p9U7jUz9UBHGqE0orDWkLZxDsCRwodCH2Pdderxd+EIBS
zSToSCCbM0GirEe/iM/Hes0qwYqpOcqgBjd7d+TQ0Xo8c01fm2JzrQq4cRqOwFwZBT8STvP1vHRa
f4UTc3FMF4aozcx1vF8VDTscu8ZWkoI00bYd11iPbmJ8BBCXo6FiKrWuccfWGE0fv/rRV+G93N96
t3k0ygC190aPk8PIhwGJI5zidK0ejBbaIlD2lI1yeuxeupV4/3aBwGMwezAWtM1oa6D8l8i3SaxA
L+mY52FuB1IR75qeHQ11GnMg03l/5XTd3vkob6CBBgk79P6qdIvW5EkRIBnVcPRDxWkOiegTz6vN
FHJfkFeuiB+tdYHfLhoADMBmgOVcRPqOJuTtRNBUoRg3HBNVQ9o0RMt3DP2elXHdvizAhPD7sIAA
FpwWfRGM4NoO1FDCRHalsqmSVLWAY+D1ni1io63SwhkYJnaSCm+Lesx+OrUdzXBQOuKng2+Cxckn
aDHpLED0fFONh8QWfBA53t9h8wa6Po/4ypmPec7kQW2C2sFhJ4VaKQTjUSt6ommhzgJ1yPWqofZW
tCrntzT1l9ao7VxrWi3xI+LerswNv5Ycsc5WgKNLA4J2G1S5FUjmKjTL2oi0ZNuL8XgUAPbynkMJ
2+hBFl5Y7nR/5vibZwsWGBJGoJCAHgKa+imvGScelDLSdjwGRW4FyQdbWSqA9VGjD4fqSfHR3qC+
BmpvlIBuB+NHGJ1S3460HZgOCvQed3+k9yxUiDpzcgxf97/u1v2Bh+O3mg7ecB5lhGs/2ytKqo1l
Px7L2N+HEqAgWglq5yBbk3xeWlKg4VU8LJGSxRG+NiTnrcL3TDMeJ7V59MXK4dPg+f5YFk2gfxLT
jHoCDF2bUBixrcUeYwm4AE+WjJMwGHb696EFpgxYWFxKcyMsDQ0bc5krK1kaj7kH7T0PfsH2Fa4x
KtDH68FMDy6FdedkTFDp6TjWpjxI6bapqlpPm4hf8R9LC4j3mcIreLHjYFLPhiTp86KKuPEo1cpB
wsZJ2vQAeiP7/twuuHu8fKH3ADYuVLZpSFeSKNgbMjsewz44ZWDFiKfMrKrPcY1tbOlcyiDhxuUy
F9HpOH+SapkvhXg61l30XcWakeEPgjqRwU+aWzb1WnnmNmzDm/7CIHUCmob3BbX3YbBt7J6LdK74
I2ZuwgK4TXj1j9CZ96dyITaFRVSfwKkC1D2c/vU+nUDwmKYAKh3TaMtB2ZDntp6cgNGsIT6e1b74
d4QOxTj5Bwj0berMd+5/wNI5QTMiKBXnzBHi5Gv7fcSVArgspyMwlJNeCX5hM7wQrAzzNmEPv6cA
bzYrLyl4UVHHcawCJi1DBckLJXa4wuhGo4Lae2N4qUyis6DYaFoGC5ddMKD/bUtDmPgdmH1qlGbD
+KOXnSgtt1UjnO8P/zZTOX8Y+nJA5TnrJ90QevJ1U2USPmxgDjJgLGABDxiTLw/cs1BYofTRr+V4
lw4pJgKAIkCz0flEvSt5EaXyWBQmnB7fZDzBAqZikyVrL5ClQzp35IJEEwICGl304vlMGxJ2mo7D
0CVoLo/AXqGWFaTSQaDUB3/vz+NCRIbgG1xOyFBhI9PKvk1QxNrQ+OyRyxvWzsP4WU0YCSKxQrNP
syi104pTzE4c1hpXFk4sDINBVAQtAKSbqFgEmFpVHOsAhs/8tnJ7m+/1Kds2P1z7fn+IC+t2ZYmK
Q1I2FbgiwhC1NNuUEig/QC0ZjMpK7mdpQCh2zERocz8l7RDENJk0aHKPR/Uh0XFGypdTDsHdQM/Z
lTBuac0uLVG3xQhBI9HLYamKLU3+BoxQr9hjjP5tVnXrNYLjpXEBNYRND+D5LbOaHxRsH2nVeFTY
xFQCH0AszhBUYwSlO8uesgIFUs+9v2RLI8SjZIZighLnpmuKryZQ8qY8RoiOBPE4oqUbzHEZCCqt
LloB663ZmiO/iyRD4quql2i4e1mdfcyB4wdNBb9bU9BecqRoFQCWmmdBLwCOoGszkP1QUrUUx+Oo
AYDY5of8/0i7rt3IkWX5RQTozWvRtZWaLVHuhZA0M/Te19ffoA7u2W420cTO2QH2YTWrZLmsrMzI
iD4zpCGyvEjexskhYswKCJT+JIW9ndHmhUHGwfulyQ+spIdIzzuj+qul3/cnesHZXH3V7BQODNcz
TIgwaPDR8ax2Wz4CMQ74wSD3/Re79nICZsfQU3EI2RapFJ8XE1JnqPrw/i/U5IiGnRv1WOJqxeRC
GDIJH4OGU5DhZObxzpj5cZTQEB67YR3PtwuPNbVg2yVfkmzen8glJzMRLfJw2vDdc8Sbx9G4q4Sc
OgDXtZveU0eLEfEUjARabu+bWigrAD6LMXHAzk7uc7Zj81GG36QFdeLkqeJf0vh3onw3j2pkhPSh
qV4S5jUr9k1qAFMJJrvIvm9/aagIPIBURMMqcBmze5BVmbqH+BlmVRxiGwIf32pIfZPWcbKyfkuu
B8lV3A7TcxWFm+szw4O6Txs53Lj9oKdn4SkfH4U95UMQHFh+sLZBF8d1YW22QauBFj6Ty9SRStQe
O4CE1dAsW3/lzXoLu5uyEbjY0VKBFyU6OK5H1YwI0H2onjpiZ0Aeg0W6vXA07T2rCpLWAHoVZiRt
OqbS++hXVRsesiPxyRNIFO/KelvyEYkOflLoPH2QhuewUKHkoxzlbOVRsuQYkX0FIg2tq+gAma2z
N5TioEoedYDYZolQCacW1PN6F1ecrgVhZ9Qgw9ZztfmLLBF6DJCxQV4UkqnztG851kWtgDvPUd5i
ENzztaH6gIhv03Iw0td/vZkRZaHkjVgSWPR572CMTqcRjz/WgYSEZnJBCg2dJg/Nqk3WxKF+shGz
9AvKXJIIL4ESNMgfrhc+irS+l5Wec1TFf5YTNjVyD5FzMnC8TseKNSVwjRtDxaCRn8pgqJQoZ7UV
m258OLJzFQ7ZIZZD6Ou0crxXEf1aStf1lhCGPqkSrT1GvJgZasJVhyLOVTOr2iJB8tDj3oRuaE1k
mwUTWIj0lIxscB4CXyVs0uVGgn6vFS+1cLOA22J60CLlhMLbbJcXbVNGQZsJTt4e0qY6puNJrVEy
UNWVbbrkDi8tzf0RxMvyknaJ4KSKBfwCAKQUkVBlBlm+4cIHJQEzWBfqcQDtO9+KPkZv32YQBR2Y
9/t7ScT6zdZ3YqHFm5CF1CrqQdfr26L2V2kaPoTlMqMWkWBfA8Td4rZwLC5NTD7sIlhpmJQOWhYL
Tizt5fxBqdBggFhiklpRhsNQPyhAAiKpmoyHRoauI9iJIlMA6ic6/81Y8RxCSINLb95TxcV1XDdy
KTgSyxwEptOVOFx74k1P6Nv5/MfGbAtFVctyTVMIDrRcBSOR7VTPE12xq11cmaVnJG//05jmG4nv
0F6VpBhTiNS7BGQWINj3LSy8WgV09mo4EqDrQSvabEjCUBVUzRjRqYftIP+pxdeGiOPv1rPS7xJC
L9Z9e7dXGsyhZQzll8nrsLMLtG54WgUg6HOwM60wexzSDZusCXLdbnsBZSTQu8hwkSi88td7UuPZ
Wo7B4un0AVrXx6wBKzeqSivHfJqZ680A6gE4z6mWhH/NVUSZOoUUFyNLTmPJJWjk6YHRIfRWSW8u
F63hIxfmDW2V6AFBBzaynXMN4yTuII4a+pIjl+mhBHSMMTKh+9eoWg4tqUgeoSwB2PRNlqwaFLYX
lBpD8orKqrmmgm5GAxZYdowP2RCEpixS1Srjntv0hQKqt1YJHhShye2S9/NNL8XRyoa5jZjxST8J
JVz6uBJnV1RFIzATdYXk1KaqvDEsKcXvHnAzZiWGvL0d0F+HnSEjhwYqvRsWqYbKoCSvOYcGhsQK
JP+WB0sa11ocbtdRhMAt3lyT/gB6a2bDCSb6ozGVObwgy8QGnVpO+ErQTOTTqs39o7bwwJtsTeda
QB0QUJvZMcAVykq1xDkcfQ1r7VUYIpNHaT1mjb42OyXUW6UmaFlsVArYlR3K/CYWCWQfQwYAredK
NGLgb7pf97/rht0ChS+08WIjTzONMHrmA0oZtO8haldODxKtBkygbX8qyre6pF9dA0VK5CyTDmS1
PqsL0WOUQxutfazK15ztnyHnSuSM/yVQdeXheXucgYcSMVHwhsj0z50G1/V9BaJD3uGYnZLmpB9z
grZEtQqsnL4MDCnGFe++ECdMJmFt2nTTNXq9QEPvZ1yEnzjpeexSgPU9I8qTiPhsrDMN4gY2Ukn3
UGpEjoXHoDdZKdK9Ttn6VbtyzH6SQdfeDLRG4Aeemr7ATTzf/2qZx10/BqLTV55m8gq06UrINW66
saydXCxYUuSMB7SY2BFPzeUNA8Q2+lD77s/K9pi8882XQEmTkxCqAbg6e0zGVZ3KPhOKjsINRApM
hXlv0IFdqxHhwCCcPDQ6uy8jq1DM+5ZvdwCm4MLwLFpim1gRahFTEGsFOCXHHB0vKV6yeqrtmPhU
ByvvroWMPXiZUfXgoUINOp55KttTGQ4gqEp2gkMePEMAFQTgNuNESEEyPcmaDNq0pNYEiy1WcBAL
vgGm4e4g+DB1NM/R0LGQeozftbIjKCEJU4Fo4kfvAcQC5wCpVD1MQDNpVYUp1MT/hpvIK7NINppX
bEbxGEZb309MTR1WvuvW20+fheoBmFNUdOTOloBXwyaLxF52GInfCPW28EGJTTkjyyXL+/cgWE4S
IKInohVfxFab89p2ASf2gjQqTosW2PJQgSd1yiZGoxVFTyPwv49Vf8zFbRCNe4VbCyZvbxyIZOP0
I3OC9b9Jz7Z9hhKJ1ilOI5g9aC5l76mLDlH7lHS/kvKsvAygy86GyKZTH9grkFvjsNI+P902s6N2
9QmzQIlFH3Y1hL3iyIXOMRYfvwB7iuTpUW32ETjC75+v27vvesCzgy2oHM0YhioOnr+y3heQbFKK
EVgSNV97sC/AHmELfAT4Z+JLm3eA9VlDgyYVFWcI0FRZvAQovcl7jgLLLebNFtmJCMALxUi8Y9ye
7o9zcWEvbM9mFdo+EdhpBcXRFDssTrl39pNDv+I8fk7obO2A7BBwTECaiM7uabYvHl6AMEhZnQjR
WWRY7JAy8SAi6iteBx6ErI5KQ4s4FJKbUgCmI2zA13ssa254DQu/KKHHyTTeZmDr8LOEYM0ro2lQ
lUGRJXuI0gFsDl0+QqtIw1/2jYxN0JfRhUHmbZo4YiHPShOqQiwDWF6j83vlN1qTw0IHW2+e6uHA
Va4KWe03MRghvEmnbABOAVXsSEhxu0s9VeQdCEOY1hLFAmlCLgQmUGcycfqlDZPofdwknw2toU0E
xg+QlQoeZJKSCkAkOYiH155tvd7IQrlDm6bApTpUhdGtkzelkumxnOZvkTK0eJFJOXNKQecFjjAU
SCV9hI6gehoqxO6/QVEuYBP0AzIYQICPX1Xa1xkZUk/KHih83WsLDUqQyKNt4xBzSVLqReWlBpjH
etALtmoygCKrYQ6UFXyIRyHDVhsy5iY2eon2X7Ic1Klepx2KLy3P55rNUEn0P1OtgMdhWykvrTAX
wa85pnknuGMtJofRA0JtpaKwcPJURDbQ95kIL5Hpud4ruIHqgE+j8AwG31OEJKIffzLKsBLYTc55
tiNRRcDvhxKNDDztrACdSimIjnwtOjOS9IqWqge1D+UVH7JwtlDMAtxFRu84jvb084td7wlc54sD
g9xTGukdBMv7naoNRtU9/+szDJoH6IRNHhp0SrM4nUFLFmhXk/jcREiA+YGlhnvRAyA9XFmaxUm7
MDR7fw8DYkAPTNpntvnyMpdW7v2BrPx+cRZjdmEBNpYxj8+aEn+BHp9ocruCdbxtYgOW8mKy5lWN
QhpzcNWn8Tkm6rGCxgL+cPvAknswRgJAKumliD7f+wNbyFxcW525Wa+UEkZgMDL5Y7DG395J3MaH
9uC90vf7lhZOz9XwZqfHl5lOxsmMzwMIItgEj6UmbK1Bgx7JfUMLASgMTRBYpCfB2To7QHiaiA0I
RuNzlIB8GvEu3xNouIqHzAY6/r6thcfHNH3/GJtNX4csTEQjGCvUx/Szf8B1WJdGAmQMgSiSPhwz
eyTGGrXE8lz+Y3U+l6GIJwNTxudWLA4jLTdFypckbr3t/eEtRDaoziDCRbYEp2ve5eiVBdAJnqI6
uLlOlI+JV0jQs5N3Y+M06TvEbFbmc+mcoag/vSARSXJzDhkwWmQektaaI/RPnLqDqPnfGMBA4JAA
+hXmj0We7QBh8jvwD2gHUX2k/tqOWJqySb4CD9GJM2yeCWylZkgqxfOcvOF1j3tk6EjCOrVaAW3+
rliya9mmhWB/KtahpgKmTQUP4WtfzkGrVeDLgJnC73SEiKhotOFL1b8U3biFTPFQGm37pOWWOr6w
SKKLIOHXLKks9Chf8ZK32xKJtam0M5FYobg085J53sU5SBQZBwAnXagGAIDRVR6tgJsXolK8NoCH
BHQBPV/AIV2POGFKpfSyyD/vv8Zz9CbJO2pL6H0DlYPo6XWBE3f/GNx6FOjR/lTLVBT32J8Purgu
FXHMxEBKwrPcIJkDX1JSOzslf4KQs/zMCteAIAtOWcGFOVHVTJk0YR4DKAw7DFmMSAOKFHodpLao
vWrfEnJqnN5yyY4qwZHibXl/mEtmQbaJtyxCYVCXKrOwIFKEPJfbLjzXgPEY6CNJrRRPK9MTqv4M
vFe2VbR+QDjbB1uoYHOuFmeqdf8jbvcQsIWofaOzWZpYsGfem+lSJP1qGp6LcFRBAaLg+DQ5sy0k
b43O5vbkTIJ7CLPQwA11CHa2XZVu7DuOjbKz8uTXxBp20bleeRre7pxrE7PRQO/FS7JuMsERlYGG
MkFemGSqQ2myhzAYiCnM+/O3ZHF6hKMPC+9hOO7rw9H5YaqGbJKdKx7lVUI1kgkHXzPyVu9EEeRL
a5tmHktCEguk5dioU9AKau/ZLKJU6Mcxp1I3fZBfwLOL0uZOqfa5FdGtB2GPiDC9rh1Q8R39Fds3
LBqTbXS8THk/hEY3XTYoASZyVLas2/mfA/+UJ69hIxINtRf6mYaNTftTUMe7IBafmrDbRoxnl2pG
lLdWInXa6Gq4QbYwbT7LIEcr+x+JUsKuxHU3HVnTR8JZoVzDIT+FGuL1iqDkm/CxOFBXPB7fuJx8
7D3QMHwPlleQ5JWe88rIHnzQfejgUnJe7m+HmzM9sz73yaPP4ThlI3oS6117hiBeqryyjDWgGlYb
I6lWnQiP4Vy+XyaD8Fhw8aDPBEnbzIlkudp1HSdTF62eoxLpg6+ZHlroxvgBcXMnBkfksnfscwqJ
Dbw1V4Y7dx8/1lGGg8OesDTzl00ksyF69xjqtrvafBssIx/thDH1CLNrdD3JV47b4uoC1fBfg5OT
ubgb0O5OgabwWXcoJVLgIdz0OjSZiRobw1cbU6ICNZhB6qH79oFUKh4YxASCIQ+GL9u9aFehqbVE
HDTdX+sFnPu3n7mAdiuy0YCHo3xx/WlynjEoLDf4NI58qAmRP+t4xb8tmhAhefuT7kYLyrWJqvEA
IexwAFPCQPJlo7nDS+LeX9MbWYSfcVwYme2oOAnaRuZhBIxZoJPI9XCX2rluy7phUas4ZFvpYPWy
Drl0bCgoUYroIgx27D47htZa6H2Tbv75GsT8E4QGT+f5BQXMKbrSlIJ1fUX8jtrQ5GswUMUmk/wR
vWcZHTcQvgwthUPu+V9T90/G4e8QjQCyCbTJbL6VHJlMIM9Yt0cpZWjfUNxogW+U0bW5a8EkLSEv
FGSclQeUMMVLEp3ur8VNQ9TPB6DmNMUlMlQUZtsdeZwUYkJYCy96auW3onBku31RfT0ILPFZfBLA
jirWrD7Wdh0QmhlN+yjgUXT/M+aX3PQV4GgWFLR+owrOTj7o4tDhx4UcJjLr8jIR2FP5UmlGuEW/
uVgZ1biSTZ/mdO7QpoIOqrqQxUGPzLUxRa2p2Cc+53IqsO84R4JI2nolgbF0i14amV0SY1nyQ9TB
iFbbg/wSVQS6uWn3dn/eFm+DCzPzttS4K2teZBjsn1HRFe296V7SaB8EjiodE8hm95CO3d63uTh9
U3YVD3LM4I+M78Va5YPCMQkNAN/nTe2h81d+vbjkglDi+P/fPx9SE5eAQLE57wq+D26+mhVDByJv
BW/5rJxkJPQpUEFZlNFPrq/SJwYcEiLxOz8rjUhWlYGIGrjqiOiHoWb1Y5EApudBrKDXSkxJ1sba
YRDyGjdYxNUo2zVtDfAVGCIk4LJLsGsUHtLkZtoz8a8hTaBoAnFD8K5WFDeC3EjUhw5q0gk60L8a
r2f+CFKSsO65zOakrm/0AkndnFBGq/B3ihSqYx2CEzMVEvEl5zJVNEYwLdSQt0ckbCdjVr3mUMUL
SZoL4q6UWAQ8qugNT2Jed411f/mWt8zF/M5C2LrLUy1tsX5GU29BK7lB70AInIaO0s6aVMgNw+nP
wb4wNjvYwE2MJQjJOLc6cIZV652RbKkVbtTfaJhtHumZJ80DCIYs1gj27fM6x/xNSW/+BbPUSstC
OE0qp+3KnhCxAyrR1Y+ScCgTs6AnnzWHYqNmqgHgDVu+gVzN6IDQFD1nDKy46cxMPWmr+mqTi7lx
QRfTMqVNLs5QkEt8mcvwDgnwGzFB21zivfKk3Nxf67WjNLtdxrqhxVjAjD+itHFQArPTbIHNAF9d
ObWLkTsKpgBWIDRGvXg2zRqVuyzhsNAgJIYOXAk+hfCl27Z2CucaQUicPYgbAPY3yS5y+q9CT0oC
tdF+5SK5Kdj/Z7n/+Y7ZzMYF0ISsl3JuCgDHCZQHw149oOBjArLwen92b3KFP7bwCEDfA54B4lyS
jw2SoR3zjHPZ0ZRtP9lw0K/mDM3x33bed/1YUD19WlnSxXAF9dn/Gp2tqUdLtDnKOecGW0RoNckA
txNJhTSloT52blVYSWzeH+jiXYaWbKgnTMw8c+wt7weepDYF51K0AOWZ0dYmFE/v21g8ERc2ZnGI
7xd1WnCwwQg668iZyWZubuQqGceVEHfx/oLACm6uia1ijh7EmmVSDaIQNFDZ3tRhsGfzlQhjutxv
jjeaewDjQWCDPpLr493ktBcGPB3dPDdL9IYBCO4fCpmwJ2nYhtLK2VuzNpu6EdyEiZDDWuXZA8j4
Hj2SiAQIcBDn3l+kRX9yMa5pES/cFkubGDx5sKQmRoNwODiVkdl1X9FaVndpNwCuqiA0RgYUyNVr
Q3w1+kGDEMoN/6Dh3pKbkHDRe47SAif/zX14aWs2qDyNqj5rK96ljywCCw1Ef9y30Cu6luv5Y7Ur
1qh/ljbgpcFpPS9mUW4B7x41GIwBGoqyjSC9Jb/vL9TSlrgwMW8JUCk30SfCRKuLwKcfPrp99qJy
RrCSC1n0RpeGZsFE0Q/dKPkwJJV0y4BDPKAv3lSf+aRYs9J/GMSnFuyjSFuH8sq+X4xkLo3Pggt1
yP0uyTPeDbQd9QwsHsrUnEwyJwMb+MqZXh3q7IbztKGuOx5DrSsraYBw3voFmHd2xSHMz5Qd9KSx
wnZTr/VoL14zk5QEGmmRjbvpoBVrsUz5pObdNNDplOkxVMXwxU1VPA7PiSVlWzSGmirYffqdbNHe
uL+XbuqY0zWHEsBEPTJRJs7T83wNhNskNOp2jV41TxmQI1CJl0wh33GRzcqHWtwOoqGdtLUq8A1J
99z07Kgw/Fg1DR6vrvRtxRuofW1xPKsDAzHaxLIY3cv0Uo8L3dsqjrjJA5Ls+D3PEh5/gBmzxQPV
2wAphPtTsnQh/jMjN4nmSKrTHl3nrAuAGOGI5Cgrc750fhVwzQN2jPILINvXLsJnUHXxALx0e2RZ
7SIw+oIMge4/IwG7Vm+a9u38slKBC9emjAywEDP/N+ZSkwA8gFjU4L48AzjCHWR6HU/3Vm6PpUHh
8oBOCBgpQGswO0DDWCWx33Oc63lmH3cbT8uNga/NvouNqipRFjglxZpMyOLuRVsaSoMT+xcafq+n
EtVOthsLFQ/xTUpo8KCNZn2SXjySnsz4Cf2jayXPxRAUaWxUsyBzNgnZXFvsBKGjY6xxbkz21eHY
2yBALy1IYIvn+9tw0TOAhQK1ObxrIZ803TQXN0k5VHEQAI/qhuNHz/xmlG3v/5LrbWYWdhXpfGCw
LHgj9PA96vflmv7L4npeWJ+NkxHrUfPyybq8b3Nb/Cz911jdVv6jhAzxWg1t6YWhAJmIBPTUJQFh
9+vBDmGNH40h7452THV+LHQNdbs3ITM5KCnWMXJGZnXM4k36XZcm6GrNHMmzvNhIWw58jv4fyLdk
+hoKYjqJs9OD2hkoSqceKhDZzS7AmqLPNFe50dXwoKdlaGnJmg7LTX0UXvDKxuyea8e0k/kMNpha
tHomtURGPMi127eboTqCR31gjKAC/CzvrRzECtX//AWzo5tVI9/SWBjdHGxIdWej/4AktWgOiM44
Zt94/r4r0R3gQfa7HyxRS7dlvVImXpxptNICvoAqH8DY1+sP+Hw9tAM7uqPQfQyeojNR9H7/QN2w
B/3M9IWNWdypKnmhlBQzPdqTVEWwDba1+fHog73ftxsynJFo2oqPMnnfPU3qOyvmp4W82UwogaPy
NtE+zZV0o1bihmSQRvft+PHlk1xn9BTiy7FuZ8R0JxkMAJ83ge2oK655mrs7huc1v7GphBQ8QqPb
UruWH5T2s8/eEnnl5bVmZXZW1JzmPZqvR7cBtlLXyvZUp+qGRki/QZXL+qvJBFkGp4FUBI1+1/ul
gGz2fyaz1RvjeHzMrNoOTUrOBLP5DkTltrSenF/FyiIubVM8/FCHBnsfugYmr3nhk6OBheCNhPoc
Byynf+ah735/YD+Obr5YFxbmwT2HhpUKWS0UaNGNoatH2e6MnDw+Y3Oig/JFO2rHQW/IN6QosW9D
khlAcG8D/Rkllt+vhNk1tgTWemTadeiP9Wu5/J8E8L3vmy0zkzSSn4X4vrcc4ZGCrF9iRVZu50fv
5G1T3TYf3MiMrcpOIao0iV70hIGYCYKO+zO1dBPj9fjftVBmWyBVey2qIkpdw9+IOgA7H5mRH+nD
uNaOtVQ1vLI0c5CyUnF1qaEmnGLIkwpIhiGrW8CAJ33Bdx/1yidEiT1kH9a4vn6CwXvzPe3Iix0X
w5ukmvxj++N5Uh8pSUqCbUp+BMcn7ZHTd2sVJlhuN78PrwWpIDjyo47tG/X+119dFijmcMDPAmcO
3ND194hiLQheQEfMRfWcgwzUUY2+ehCFp5TjjNDKWjTCj7qyXVntKQCYz8Ol3Vk0lMmAHjcJ7PI2
2PLe6t+eRvTU2qwc8KVnJ/BZ/4xvdhF1YS/0fgw7MWksdmdIlOhuT36tDGfJW4JQFd31qEni3TUb
TucJIV/KPQsz0vfj43Npb320Phn0Jc9wD2y8h5WS1eJxubQ4Gxj1UZPhelgsixOIydFTqPcJ0olb
yegOwVGTHrw1BdPFyUREB+0QAN40lCCvNwsDzCfoCwbWPXYGUn8fYWz7Ww3KGrG+qrCwtEEubc1e
OiHywiofj3i2teT4BjrFXFfo0TClNdKxGwaBKY6YWhDAjYCQENHK9ajUYPS0sudY10BXQGuXykHD
KeR26dYmZ4B4iFVb+p/sCEBPYjt74flFfHgBpqeGK1xb1em4zY8FWsamOjO0Z5GOvP6WqKY040SM
+hi9+Y6iczu9sQPsoD84/CubVpiW656xme/vlcTr/Wpazj21vj6sj9bubXVnYeuez5rekWR/ev5t
vpqfpf5a2YOb6Bt0TBn+0/p780bbYloFDBydi3j9gU1zdoL6QY0TjUEtoOnEbD/GqVFpiYo1p7JZ
e12wk/g2MDQ65I8s4+Oy8kZlH2dy/hLKGbuVUKWzI5YqDx0kjPC/Fb0tgCr6scY/JASqdcWDLd4i
aGOeiJ4ldFDPtYsYGgYFZbwpr2B4tsISsYcChxFtDNyN2tbJv/4wxmYvbVsCtT7zvsNZWjoV+kyg
OUaMLc27IcoMFPSgN+TcmpqU+xK455GxAgIY+0qwuWZo2rAX95UapULgIdnvdor7IbZQ7uucAhNa
rAnGL4bzl0OabYBIFnIMCWkUJSPG2x7xCDC1vVm9ByqRTORUJInEJ3VfoJuG/Nq83J/QpdQDUNbQ
bpvqJrfLmVad5ifgZXOLyocK2lESfotogW9BJi8yfzwQx7CMLoJ1vpNJXew434xF+nz/Ixb3FPID
HC9MGgfyPP+Bfg0vUeOGczPfjveUaJ+vtWU3PjnZpum/P+x2jvIOr8MVK3Eqt3CBadPZQy2bhTuc
R8IqiPwVWgFI2O5ickTapTeBnY5PFRJMjnBqyUq4t7Tc6FNVkHaZJh2Y5euNNcRqIobTfO8FcIgM
5LX6kxGqF+Rh0hCc1PLKfaYL25fN5v4kTzH9zOuhGWZ6aADqBn7wmbsvB/gfoeJZN+stLfso/e+m
PyQsaXOiCJHRAct/3+A0knsGZ0dI4jNJHZBoc6NvLj8qXAVw7xrwb+GY4qE9qUrjaS3DIV3PZsqz
jJyXsJF2x7EzqR5SI2tW+vWW8EdXVmYxhyjndRGEsEJr3d89hk68YU2BcN+8BiUiQ97gTtyk/Qtb
mCvbZel4TpkEpOgUcMHgmrgeYCgHYqh18LYqesp99UnjDnlqprEJkEk5tEbFlGT4rchkZPSkdvOv
+2u4MHQ4B/ABo2Q+RZPSbBHBicylHW144Eh5R/meoBixaXPKA/vmhWQDFAKkHkx6um92ARBxbXa2
rlB0YDIVzQxuVjny6Bt8BoDdUbPUflN1RA0TUiiWZuAT0uBTOrPIc0iGeOhetNgoq5Xo5NZH4GMm
Ih6MHzXtecM1miTrGG9ZHuHfNiTBfq1oM52864Ny/ftnc4wUutAnLcVgmQZY6a0YBjpSi7pE91n1
JEJhnK2PWmSU4zanx6Zb22O3B/Xa/myykYQYunQaH0j189fhVEvPXgxO1nPsfdLPWH6E1JXyK4eA
HLCs9xd6IbS+tj07WoUydkIpYexJoqNm1dUFYfLT8FrWmwqYaVOs10oJUwB9M9viFHZBRQctI5NL
ubjZW74ZY6lErl1AnyqQm2yXKkRpE9AiKr0sPsUezz61NSjJyo5SSUd/tySgfTWWIWVRsoAZdqkk
jNZQoq+QpnFRQOmiH75i2o+fOZvSX7nil6l5f6JuHR3m6eKrZ88COoYJ+n+AEKrEgIAjZyMAwx0H
e2mo9Uhdk59f2BHixNLLTsVtXMqzcJzjmkLNQc8DEvRXsdyq0XO6xlpxex2ByAutSoAxg/cJebvZ
MiRqL2RjN2FgUiAbEx1kFVsmiA2leBESo0/Az5SvpUCmXzpb+4mKBxcwYkfApGazqGit1raiCJBI
XEV2kCafQxcwK6HjQkyBpBr4fibCcfDd/bw/LnZY1oup74UB78o1oP7Jrq5IKB7bgAdg1rO6roQ8
WEUNtbXC9K1K7BaStFlJpOh7DVu1UHzBp0x6SLhC0Dz88/q4+BQQD4HdDd0trncsniH9YkjmNtwV
+9owVULNTCTC8/2NulCChknsHNzHMi6NeUqACdSxZSWU6kCHTkBwDqIt0eAeBv0Bfdd/Eb8hC60A
fwHuMMjmzDtP8GhSlLBPACJIcBMB0Vj8Yj95HZ3susoRD/rzbzL+47l/XWOuXHi5oRqJmQXiaGIB
mc9tOMqMxyD4cIOcoI6FlqGNt232ykOD5O2+MXe/yy0g+C6ejitvsAUXdmn55/a8WFWpTNLE5wvB
5TqwzRQ22xPIEmfQFk4Mb421e22c/CwEYXja5wyDcbJ/CqN8EIytv0t10uneY2WKJNU9JBAbG5R4
5Vo9bfEoXczxz8PhYqRgNxJTL4bt4jQ0pLUzw98LVlDrbGBCh5m0e8yvnr7+RcrnanHn0XKDCL6N
FRhWCiP+FPXkURoOoLJ+RoCRrLEGL92CyCsJkDBDKkkCjuLaGULEDdRh2gCEyrAfOh08EL98ySo0
AzjpPvik9RokZsnBXxi86UilnEaDrsO1CzA/RPt4wiOOPYQdGoj7w6f3ukvwBll7va9Zne0kJLqH
phxgdUgPbKbXrd3KfzUytPJBPRpOHrmk66kEXUQLngsBeBv+pWHErcBRA0JMROLdUkA73DZl1Q8u
+1N7VsJDenjDeJt+TZhw4XKbOIEANcUtCgmX2XomQZwXbJgJbq8P2+Sr3foW5nMtduJvb7NLK/NF
LPIhgegFrIhHdJp/DEZrcx/lW75FGX8tgX/D/DVpAwCaMPH+gd39psfJC5ggDWQYk8hgvTUhGAJ2
w4g+FN1hNhyq3GZMCiNviPa8Roe84O6uTM8itqGmUgzGFMGFhHqu6WF4EnZQNuu/oDD57y+vK1Oz
3RNVHAtmApjaA/LhOMpTjvhPF79R1VyFYCycBjSR4HE1MQNOidjrndrysp9rQi64lZU987qVbs6h
XRusZebvWD9jZWgLEeSVuelzLlzpKIyeMkJH1zWMyjgqb75ZZ7p3YB/bp41kSM8b+rRicXF/ihPU
GtAWaOhNP7+wKKlcWcRZK7ge1IH7XSeYvHqMvkIHygFEPHXVmaWHOsvXRrq4X8AcgO7HiW7kp3nj
wm4bIc/Vxz3vGm/8juIVEekPkBZ3+yfkdJy1dVzAf03pIzhocA+Cj1OcrWOjxu0YNAUwH6lZsEas
6V4bGgkI7nkhNv1ENUAvgDk4FFCK7YucBILDKYiNwArXjS6X7ANIlOa8XuebBviM4hDzhhI8Qa1P
rHT5QwCR32iwYJZCiSOxVxZpabI4FACgGYf8giTNDldQANDcSy3vvhgUREEb6Cl3GxZ+C4+vEk2i
Z35v1JAa0tG7f9/0QosdJu7C9Pyw9aUUpz6ug9EBjx7a7CAE4nSGRqSQCK8g3TXfkRbTxZC8v9sP
3RE8JJuVp/1StDrF6JCyEtDehqj9eo8OPnqvNB43LxixkWDJwZ5AGh1tm07/F8/sK1OzmZa9EBBe
ClMvhvGGFhqIhzGEO7KInTYbcQWI8sNyM3vqgDAI4C7gMdGwNn/mIjGm+FWMW096qz/ZF2U/GN2z
8BCbz4puHzhd1wMSOJX79CS4bkWI+ZptDgSp1ifHt/6Ps+/acV1Jlv0iAvTmlV6u5du9EG3pvefX
32AfnLOkkkaFuZgBZgN70KkqZmVlZUZGUE7knQLK1W8hPrQyjAipjAqkNOZBZb2woX6lVyKtmHDP
lSGYAaUnwNpYzANff8tOKpV4VCcB+qOHaKbScnxrQNaWWVAieey795JiqJH/s0WkMiMz8N6Yswje
JuZWtKNoTJ/hmbFGe519qPpy6RbGr0Gxeq8sdmWViKgdGhF11PPCea7OQwFx7S3lZXfSZXNnrdcV
aP8+pskIXPA3fD9e8L3LCozmeLDLwh0KkxCcSlMby3gEqEbX+Xp/jPq3xybuecksCoJSG1Ap0t9b
9iJsV1PIhXyNxSUj8LJapQvtOkqXAeXI3xn3ml8U4F+byUxRACK8kW98VUkZLKXHpNf47L9gwndX
25nZubqerr/goHitfnX6D2N9CmBZHR2Ospvyve28/A1EglhLYuBzoSqcc5CcYeIorhPJyYRJe9HK
oDw3cT6efLBs/sgeSJ/Ao+BhqFtkAmUDbQ1M7Gll16RW048Zh+GNchR0KUaSoctFzH7yqQjMTN6h
36OXJVODFsVnAhz3yANX4cRFCUpIvpR9JTKEZmzZSxWrYtrPCdMgT2PQFp3eV1P7Bqh8u5i4AUJM
qcZIZ4Wv5VNeZMmOz6sO1YSGL0ojG4cyN4QMHLxWDbCRj38OxrcoVyqUMbmiAN1oWmNEXdGABQ8i
dRNLQuIWiTK5QSH737yEdqzRilJuJCDO5PQp7ZqlmvHMIikycFwmXKF0RsEnbYap9oTtwUWPaUkd
E/9ANWdB9cEmfcXqct+3noF52vgzxVbVOkoGLI0J8e6N8e/TgfPiOsr0YYf5S/C0naNTqQJ/LB01
sO3x4E5fBCsP8qdQk7Afn4w7XYBLl0W6eG1zVGXoPKIbeg7WshEct5Hp7zmHA31DYiWORDmId9px
MIfmLuaccdpvwPwYHM20KPPgnVawNjt7s4ldCLzruf4qbXM9/8gLQyxNOTEMJndMym1xf7Uyyo5o
d8wsG8ThkETw/MlDKp6hadEx+ynfx88iZngqnV3ApxTBUc160w5PIw22Nv9l8tIEs/P/WiZvED/n
02KSQvGsvfKFEUOnwuHzdd45dbejpAN3IwByCwFdf7wSSfQFxjXTyh8yEW/hV22EODD6+ZTGwv1I
d2FDvHabtBj5UGJho7I3K3CAcPopMA8/nu2vO0O3lu7x11UWz2C80R877N3FAc0oQu4NSNG/8HcR
yhlhYkbOn8TzKoSZx3/73jtmRkr+798mMrYWVV1FmP/2eLaW5wDYvMd///4BvzBA5GkKdJRkrYAB
NXI9JwDm7zXv0G0T0WlTIHY+q1BAWTlf9w0lafvLNm/878I0cTWVSgoHLGE6tzab960NIBVYKgHF
WTi79bpcPD0ted08KuCZNmnX4r3s6XJfiVM3+BF0zQJWnCcCNuPvO94jumhhdmdxSFZO8fvylp6e
lmeAO/auUOj/X4f+39JJwCjDFazQR1h698qtt/MDwDMPijFujw2AiU5E8aK7QQYPNuT9eJ7O4njX
Z2OY8prjQoTUGEDEzWikktlY42kJOpxvz6Bs7r29vTRG7K029JBiHiXhvBGteKkYycHl3ihuO98B
pO/gTCCigL8WZXfiXGRdDEL2NhHPG1QOV6xtuPtvt6W92YR7VoC9QXULpGs8SYLR4VyAtB4RMqwM
79f+LPXMw73wqa22i7fOCg5qZT4Z0Gs8d+fYpFQU7mWIwOBh2IhFOQq/4PqbJUqbCmXHi+dI/izH
jzE/pczHyFuPd/IOVhV5/YUZIstmBCFL5FpA9HqdoybE23cRwEyl/nny9QDnQdT1NbNX9X5tNIYc
GykAo6POmJq5b/UWzYDHP+iu9wC2AUAnB7ADeR8WAV+y/KiIZ/ad2Sa9I7eLnDcx3CBT2u73DUFG
CrBw6CWRPPoKX3JargbSuTFV2RY+Wc/NMquL3UL7fbwk4a4foSUFKliQqmgk4I/xfaZIU5jKrdpS
dOY42ZNgJIv3jR3qxRHztD/+3EZJdG6f/FqZHp8mY5nuMDAMqmSbJhR8r9GAVjDoiiARNcOg5t97
cWN5KaNxfgDXMje9sanWuY6Ou1G9JKt0LS0D2WgN2onl791klzaJ6xlyWAHTJLCJRAPVD7Bk6e+4
Y4423Ex3vvS11ZSG5bL60d2bz48/AHfvA2AeCMgSAJGAbCXCRd2IMwkB4i1zLBLNFpJXNTgIYPMZ
slkOJxoKQy0dpF8MvJtWH797x15aJ+5YMeymXFTHeekbs9ppLwqLqVxdjYzfVtdcylrnlJwMjcgK
5BnCi9I1WaGbVG/gmFAWzykmVZpF6fiVkQWKGUcdRrZVc4jMJvh6bPTuXX5pdM6RLjyqDcesLpDe
Imd/fvU2QFnpm22tL3763W73kq/XgvFkuK7xTAsXd9wK4/xo3SN/Bx0aqR4YlxFUIOtUOvO/4A/p
e6c1QSkz0FRX7uR4V2aIEwP5qyRuhgLBQpoKkNyq2FMmjIzRExtacnAnLwfqGpks2P44ECLMgeti
L305LqSpK6UzapE6pyMEOzvHqPRAPwJqSjka87G78hZcbrCGcwHNUFwyxC0TT2zZJ5LfnzM18U3I
d1dG2wct5Za5bajMZkAEKSPu4B/JUbFeguZa5avdedjGTxBBddMNyuI/YNVyQkPavDSWaNam1u0p
y9NuTgNhmDh7UihFGchm+rMvP3nVijk2CyFdhIENwGnXfCj8dzqCBVpeYx4mt+PA/tQ+EtFK8TzX
3vi61hszPZRmuCnPYwtKzhdQRyS8kawDp4IiTIfBidpEb4Gx/BOUSROjW2uQVXpRUyMw01lcbjsU
jlQakCcUa7c4yuWu4hq9wuwYo0du9gECfFDl2j6Pd67oFpjAXYbAZ0brlDN73kyNGO1DPQP4TlKt
XgBShG/0+GmYB+s3pZTqmNlBH7xhXkA0grqAaAUb8TOqqVPncyZw4yoX35DwS80L0SdWle4sYdb+
uS4NoTGSaM2Bcw8/RtlLjFUHlnp4HFpurum/DwjtV2jhYdqBlIZT42DslPkDcnawVVCr8nydxjhH
s0FErw6MvV5VwMZKdDCYVqx42pm+74b/VkFcQMNQjGrp45iBP9jMtg1QBM8xXEQvV97H4w27hcEQ
O0a4fD+WmdRxsy0dc3xS7gqJJe2fPL3QIVpk9yvOOGopZZLw7hYCnYI3MJI3yOFcB610lMu6YWMY
berWbj1IB45cDMrgflGlAAMNzfCcBWxCA7jdxP95sWhmYAwZYQwwJ8JuHqVK1uHTRdE7O2GUjMeg
ylMWcjPUt4b4JoghB0f+Dvl18cNuK9UUoN0gtrvHm34Ts4mfQew5II1jxmZRPzfiM5tBh7rCkj0r
RD+n3KaKYD+299cvvTmMF+smDmMk5ZM4NNhvsbSbQJc0tGyhdgMprOYrl3RliqGPBWY2Q95BRiFd
xIqbf3E/XW8GeGJb7DcHgF/+8vhX3QJoiW0gnn51ELa5Eiaz6+WJG7cHsCkHn35x0gwoVYmL9rUP
1zG2JNNr2YyZVThSwsVtnw0/QQFxAlI9BeNu5NBExqd1mxZSf67lFVQdZAxO7TTBaHKE3DfJg2qG
K2V6Ajlzs7UwzRHp2oELXwbBHlVEdmvAXIqEWm6vC5Ej9BtZXEhUCMy9UDrfgzPPJJJwsvo/ojsm
8pmMHwl1+mU04APK+0xcyI3jD04SLmPpvdZ2knCkfKB71z2mmGcSCyhK4+VzfVwEvCprRm6Gc4DA
DRbqaTCmYTSEMtxFwvsgs2DbWVa8zXmRxUBtRNbeq5ZyZsmnAOYPIb8B1QDQTGOyBpzq1z8iZjyl
llrMP72Kzis8RI109Q0PSyd3UidsDYDIRje2MaGx8Q4APZnyJgPKA317/Ofxhszh4eIY3fwUYj8Y
oL0AtJ/YMwvEuRD3esw+AWftpZQ1k28A0hBHxEcB7AhdzMBQBR7CkPsevJ1aFjpo5yypkuwmNdKV
0DbgsXkf24wSLYjodGOcSPL8cOpAXMiy5yY/5R9eepzYZdi5IWdy0IRk/rv6z4212fkv8leOZdSG
GfF5YzRz5FPYQybv2JpptU1j2tgFdV+JxBz68+yQS5iQzBas5dd2ybpZawzgwokwcS1krmQNVOaL
v69Fug3wFuA8AHc8JCgJq1xYjcrE42uiHdqpjuxodgTWa20fABjJfdLIZ+6ucmYbQqgAbTsQmNdb
2kYsuEuBkj9HoiUlhtS40UIT3HLcIYkMkt9acyrcuJz39fh4kHn737fE9QoGdxFEMYDWXhue4lKJ
vBGTYUIbeM8ypN+cgUdHLc98XhfSYHwfwy59ZlQhWnCsMropM2JCLsnf0qn6jbm0d2pFzPcJYGrb
KedzC6Hhoxij3H38S+8dZDTCMWQEPVAovBMX8JBCIyzx8EPD2m5xGwack5uCShNzIctlfxsyZxpA
kMgspkTmAHvh3F3n1T3aGeDqrEz0iYxoBwLNXbqXrei7d5oFGCIsyVordriQnN5MF6xdolUGCtJ9
bGqLAHMFqR3aDCWO/b3TSI+8/F2kh+Qc7wkCfpfC/8hp4nZ2U4fWgLKO778rUGU3hcygRU8iriCE
o6Z1wYRPRE9ByjghlsCEL6pmyk56UFi8ZE3xEqolanLiKXf7TWZL2COhwF5STGEcwh6DS6P5kCtd
aoEnyqymcPFi6zyjCxfN3KCtRCPYN6GR0ri/blAJ+A0o4vFQT4F0FMCBxEandcJ2seJlB7lsdGld
jU8d8+H5G649pfmqLb7q4lNLdfV34PbNrCSec3j7gdJ4CFcxUrLET5dTxVIi/E3m9T8/Cw1akFzh
ZiWB6C2YnEIol+BnpSbjr2V1nb5xH4IRKDr76R9rQFAcadMvaptfT7TBtDt+gD2BRo8CmBum7YgL
PWoSrlTkKD9wraY3ExKrdHSGAmI2MVhdNwrlrUGc9dnttFlUC4AfHpT/ZM0ia9tIrgQmOwRidooP
vAqBnvTsF7HzOKbc3VQkklB/lWQOSyMOe11XzRjxSX7omw8RCB7NW/UmhsVT6+23tLTf0Nsk6qmW
1kqY6020Kik36R/a/OJUY/IYoxsS8NAgc0NgI1GTYyuwoQy+5UNpFev8KVmIe3nPL6FquVQX0157
Dw79SXI8WzQrQ1vQsKhkVLmxTzg7RhqHEiLA4iGTa7D0HsMSsLHOLDgF/7NTQl6Xo62GzrTcedbj
zb8pKZJrn73gItJWhZ8N4HQRDyB0XhR2DEb6ZpW5uPps4MbdEKwEsh254LZa8Bheje3c5l3eSRwa
fwx52//PLsjs3LkGcBUMpde/pC/ZKWB87ILMbcTiQ+SXkPPSBcyjM46QHxrJhjKf/nj55JX/ZxQM
+DPMEkLxEkmuVcpFMZRhKR0knf8FjjIz042/Ttf+Di2oLRUZOa/hytMgKIGZK7xI0HRBLZU4wuyM
umh5Rj68Jlv/XcwMUATL22KjTvoUmSyl9zvfxoS1WcEIeqa8DCyiRGTDMSaKYlRUtQOvWW23SJgV
mC3QVBIk2jbetQRGeQFXFVZHnqAadOxVmyfaoXO7VfeSHcsN/+bZ/Vp1423k1MB8ZD8iTbGVZpU4
N/GYAE6H3PQwBr/enul/B78C8lEJKlrcn//SzU5erI84JWlb+fVQYyeLyvTyFx/Zh1uCrONQsetB
NLTxmQ/eAwmjT6zbpnoMxNFjR50dg/gBEJUHsHWW4prpNfDvL46pV7CRMgoDHmoSZoKEVYyEw3mS
z4+t3FnmlRX+2gqH1C7tp947pLr9Yjz+27fnGzp2l0sgkly1zRmWHfHH26cRpZPtqd+Bv64AYyWN
pvKmEQVaR7StEcqlWe0VGeT1Osok4gemF7wDu2crnfnS7OzovbELOH4UGt6LtqNNF980+2ASZwyD
vMgLgEsn3yreyPoiaMz8I+P6Kwx6DitNs4Zlah9bl/2sNupT/kJ/WN/bVMimQ19zJpJBpYFYqdRj
0DUQg+CYijZ0tMCjEgFhZNRo/lmlTRN3uOOFMlq4eAJBJBlk3MSBKysV7C5ZGByzdesooOES9Hrr
pVSpoZvUA18OmR9wlCh0InARGa+cx1k4MXEMOSsoDH3n3XHEGPOIChzFJ2efuzpWGCvEqB9qWPO1
j8B87ShV7smlXwfJ0U90PDB/gPgLXoIXBrfBOrSDH+l7oAz+32whYZH4YID4+hjL8pMj95UVevcy
jUa9zmL6GPRNcCQMEcdN7IfSZ30sLfR1CKcfgF3kBffx/t3EC8IGkbmNfKckHK6YY7fTLCSij//6
7TEm/jzhbkMjqmUk4M8Hp/wJM8mm8hTLbvtqpqYEMXYIwDe0IDX/4kcOQQR6kE95fj3BZG999me0
oGRT2ltqs/SM770nOI9XeJPREwucv+FFVNfYblKqeYEgS4ceiwdMiI1sb9poO1Gh3GH3bAF3iTwX
ZXzwshCbyfGtVnI1j28FtKWvo3hefo2toboYeQRNzOOF3W6jCsTjXDjHzDLgQ4SXB4MQT+AK648q
E0TbNuprky8V1vxvrSA0ALeDQgTeKjfwJKavFX/0M/EYNonBqluvPj02cOvfMIB3Hq4RpGsYpLz+
PqI0JknEtOJRidcceL1bxgjVt8c2brN/zN1eGiE+TJpOYln2g3h8jT/gB+EhsJOX7Fn+6j7il8e2
bl86f7YwuiHMBBx4bV0vKAOXK/i2J6jI2UP8Lr5nACu0J034Sr1dDL6zYtCTeNWnhgzqFm7P82it
PtfVQoMADLhm1wmNFeA2Ss2L//eDiPMGXWwuGhNOPJbP6WjlBRQDxDVmr21WWFDWPvvc9dGGKSC8
QKM7q2CSDX+hmNqajSXxuOqNV0333XcRrJg5GsihMRhv9enj43fUjy2AM48t34b8a8Pzybw45X4p
Z3ETCOJRRa1WV83ow18ElEh8+5CZv+z/rU4jIeSsmE0KiqUwsimOxeLTW8SOtmQWmhNZISWU3FaI
CGPEtYm+BxRDke4eu8plURHaKgcB0Cq9WYZrWfd33ZPsmZgXeLyP90/KxRqJqJLkkzaxETYyfhYw
3SgaocXtlQ2zgcan9djW7Hf/2VkgkXb9zbSihKgLosLRLPeL7pmh1FZu00ViB4nIomACIm48+D2m
1FDe5M1gN6ZmOxkQoLdqnMrUFJby1zRaaG0+Xtq9bcQtANALdFmBySN1HAuB6SEzHkjHmVBeWXnr
xvK28BOnXo2UC45m6y9/vfD9SMvTUpY88cg6wzoy9a+dZFRWvh4onWGyhA7WK9TG/i3q74dcGEJP
dBKZUEGoPlYnW2j0ZsW+ibsMtBStqYLytQKuWwMTzK6mEb/eyVOubRN+2ZWDMIqpJh6rwPJX3m6n
Tw7zLjnTrwAxRJ1q8E5AuVor4ZxloEGptMKmSvpks1bnoi+hx5TL9QbNTO4o4aJpkY9pOTDiEd3b
RbYrN36pe2aFDRWM7hws25eaEsTuXAZX6yJuJxTeq8wr4Ziqk+vrwaKc6fkHX51pYF3xFpwli1AW
wazW9ZkWAS0DhbAoHwMl1rnixU9op3r+0DcWQN2BYTNcr/jvtYVQS0Djg475sXhlfxU7inCYmVof
7QQ5uBWbAS1FvvGEub+sgHUIVHMQjiWXVIW5lIYC559qUeZOVY4aYYXDPSMRQcNbVZ0hAbt46LSA
FoxvAuRsGUkeZjFQIb5RagiE0O+mdPBPSr5Q8cQtkbP27TclVM0VqusNna2gJszzKApCqPJ6Qz3P
D4oowvoALrOF0KrUUG9qtLIdsZ4WsgLiDIdrfErUureroAyc+QvBAsP93bUXsUQAd2AD5jT/lEqp
MckbdNiNAgiXPHC46EtIJv3xMm/8HjR5KOzMhU+EY5kEUzSCEIAdnA9O4xLd1aW/4KyeUuO+LRTM
NuZeGpgjMJWtEFd2ygyhFkK09hQsxOWwHlbyol6LdgQMwOPF3F5thCXymwnlqMSiFJwqm3EZN1qr
y3JTgcy9sDyX24cLbhktK5pc/W0CRJglgmLMRmHbTzDbL4NdCNrrbMft36InUE3ZDCWXpO4mERsh
HDoxTC4Hp/jp5Me6eJwM7OWmdGkNV+qyiJhY8qzvxR6Wxbiqo9j+0vuWLGnJWawbbGjc8Xcd8cJJ
yGw8VYUgybCs8GnLvWQfuU1bz5zrEgcabsiBHxNRC3GDyIUzQUswVSoEJ9boLXnpu4MrON4WBRCK
F945wypaZNqsHYTnG+nvqPbncixX4Sm3JkguQjfHlFbdCnCoxWQIwCPlGLAA2Q+V/PQ2ZIng50Ln
TIYYn4rgdR2y2lyTFa/goz/39w8SWijJr+KIKxom+44TXlsivhakayo/6WCpMbvFpHugOn8RrHpF
o9i5zQQwunK5pNltLuIhqGRDb5qXJODZ9PTe7b5s1ZQ2ox0c/Dd0xGjXKG0L5297YQ+4hYkpGtgb
EakYQ7EAdTRRSqUput7fQeDZWXHGNAoSYShMUrGUAKo4oZ6JvjooxdQtZwEueqRJ1tzMTaJsD+KQ
f6YIx8/DSUlUTsaAr1WtE7s0EvO9swErdoEfcEHJO+74rbotFyCEwgDleBi+voHfo2kR0X6HPO/9
xd4Cxwmt1wa/o18mC24WI12rezS+WGO0Mtu3fCdc9Hb7Gi+S5+gJqpkYR4pthcrbdOeauNoQmbiQ
ArVUkWHihxTg6ABFSW0wh+bl6y3Sq03lhLYHDtCIhg+7DXAA2Agof0EbgMegEHFk4pTPO6mHZ3U2
YA3CGsJiq8kzVJPdluvmY2lE+2JTvnA0TjmaXeIEpUk2w2lg1/8Ql9yK59BIZg+PQ95taL1eG+HM
A+hkVaiozacGOmH6p2x6x9SmXRFz+LoO4DNECTpE4CHEFDfZ52D4sIG8qogjI63raDdK395IC95/
TGiPjBDXa+FxRdWOMMI64tJz2GX/14yvAfcB7sjxnNqpXG45WYoj21DLtHuXVi66fSxgfgl05LOK
hoAZH8JTRq3xhTCpk5MMeb1B6PQ4ptSab2+oawuETyRtFJURXyWnDkq4Y/EEPXKjGy0Gk1vdQQCS
9rF73L6QEYEUKEnNno8RHrJVFPFK1IIkIj7Vwn6ANgwDFSnL7w+MsBZB+SABe+Cl7CJveQdQyaiG
QIkImohqPxRrGXyERW4//kX3XAkvCIze4HehS0dkbBWftjiKPLbYK1pgJMGznCYQcY276uOxpdsy
BNaO/vf8MMOYJzz4Our1k6rmcl+kp/a3fuJWqbH2F+UXd4423I5i6p7jgOoAg2EzYhEyjdemijhq
iiYs09MESQ7eGHO/+BH7NmQgyMfkP0rT5IoZKM20huRX/Trywygbie8BA801OQ86OS3CQ6dmkq9a
ktvSofy+eank2br8fcRWhHI0+n7ZpKc4Xw3ZuNY8YBsnceGzockn3znuBBHQ7dEvTXBDDEBg9PvH
P+HuDoEEYlYSBOaR5JiT2JDp0ylJT4UqLbWhO0Lei9bZu2MDAxIs4DwzBxO4NImvkKatjzpwelLZ
onAAL/Iha9ppFA++lxlhMBrygaDqAtEVOSDNArgnSlOanSqzMyeTQzqrLmRTNIFSXaLT7coUSMdt
rQmhF3JrIkhuAevgFCK9zDgQsfBclp1qvUT907c0Y2d9FI6r7GgJ5r09BHk+xDOAjMKFOf/7i1RB
UrqyaLwc4C9jR6uv3t+5iz9OrEPzBiUbqyI7eXXbbzWm4l+lMar2TNG2RjB/WR1EK7Kq8yBIgE8W
NQdOm7DEU3yQURNwGjXlwO9cJA1veIFW0whSbnslEp7kAB4L85DgTPx4vfwG1HZ+gUGsE4uxVQBL
girsjXLal/5PE9k9cFDaoe8WER8emQBkhZDUGOuT3wbG2Dm+ZwqMpQkAOJTraqAc4j/3vT7E+G2o
YqFNDhAiGmDXv43FPGEiM1V/Ykq39Dm78D5bFiE6OvgBgMGTi0FRC5TUegqILBMuPJC8FZyepSWo
sI30ddBeG2YNvEoOrh7JClI3CX5bUMmpW7UVLfy/WwjsiXrYhbo2FXowGPLYQFTQYlDRYtHNK14Z
0a6lTVmAXtD7yljwujyFPyk08uJPOXrFZEcNRq7HkeP2ypSga4avAYFpDYUnIrYiiDZRx0n9KQUM
AQrgnWyxbcLaYhT+Qi12sDpe/e5ahiYE/nfbE/uNEi/GuOdyEOp6xF3NhZ4cNqwKFODw4kHLemDt
3F/k2WHMDyy4IxU99J614TmElA9QCoXGWcVW+JQXPLMEL+kxUsxIVY3oCVMghW9I3DbAzOO0EFei
akuyyW3GUDG5Ya+MVmGFO16zlajRC4w3bXLonIUGaGO1H14zH2/oLc4W6YCCZYGGC+w86l/ScHHG
oQjeK17F9Cc2BicB8DiVuNVEt5YNRXSCadOWhS6HJsYODXkl+UdZ2ZQVePwiR31KQf8EurnHv0iY
Eytyqy9/EeHaQyUO8Rh4/akLMXtp96UdlzsQINY+0N1a6ozyGuT96Irka3khBx/dMxiZK2YnsUba
vDKdqYBwT3XhjJsxsCbF5NMNOKlVxuSAWPbcOAG/hGyMzcrHhDbt9p9fLVe/HjSxmCDAwBEYq4F2
Iu6duI+LYeKH+CRByWa0xgEvV+s46tIuoLxlbrInwhLxfop5MGYUWR+fIo+RFgNmjo1qGqA4hvlw
yje5eVnMpgCoAiE2Cjc4A9fRpvTULimnKT7FuqmMdmcAH1ONOu2NfHPfzGbA/4HKMnpTyp9nXPhi
rbZRAug1zGh5ayBDag1ebWi32g23Jn6/gNCBz6SgZYqZ7OvVgLOySEE7lp/qamDczBdBkwlmXS92
uFLOJSMfFRYEYY1YOVPStpWRiEmoGn08xpXelSxATxAsUiGsggnN0ci8cYjACq70AH0VYQ1embbt
/KeQmfnRhmJgOB26cPyxLAQoq3sSkO1GKo8YGi3aacxAOx33iLKVp6EgFcj9B7SbIs9upywQjClj
uvcwj0oINmAahrEen7bbaxibAS5+DnWqmW6clIpixSrrU41LToMNEgMQcddOYIdo0UVPH6KbDKAe
oVi8yT8Ji8TDSu7abup8ZP2NXaw3obAEzXi4QICb7AZSiN6BCiy+YxGLFFke9XyojZBowHas4kIA
EgrvjKfG7msbsGJMS7V23VlN9iyu6u8AMwzIgylLnQ87EQxQWMLrEZBNDoPVRAbBFao3cmGanmY6
EnG5wQD8YiYEogTx+fJ5ZIbY0UQJxrRpkU+3Rnp+O/7SODBvy2TINS7XQdx+tVYEiV/AALS5Vo2+
fhKsSKeOuVDNEAUMVummoqjndVilHiHMqDo4do80vqHbFJpYDnHDSOHk1VqKzwIQjI0l2TYUdxaq
7hvKMsLkEMUL7lwJEAyAEBJeg/OgARE9u4pVq1CYzZm91Sz4n9rUu2cMfb58P7Z0kx3N67owRLhb
MEzR2BdhenrF7PHK1yMrpbGu3rYjZht4tCFIo7AOr74OnsiR0NwZc9iwt9i2xTpeH/fUuuy9E3tp
hb+2EqllqXEsrKDsAGoOzg110DWsz5AC/t3/95uGTjewn3josOhJXJsaOGjlcaGfnUCZ+ZoPhuJE
vv7f6mThykF1D7Mt7Cwzh7T92kheaUIpCi1eUrr3LmyzRaezjWPUNAKyewHn0g5xtbVIfRkmg53X
ydO1je6fmkRfHtWB4tP3PO3SDuHSeSIMghbCjrcHpZshb9FQsShR7SYPJPaM8GaxDNq2kJvstPIk
sIEl30NGeUXdVoUIE0RcY2oFJYG2xnYlC95hMVPIvAvGkdZ6nXeDjM+Xu0XGtakRpJDDSqKFvLSr
taRn6kKpDmIGPVqwFT126Hu3waU1wqE5ruO0scaiMIbwARIA45fyYeaNf7CcPy6YizQtQbFQrmS8
3JuFaEZLyl+/G50vfj85BlRkIsQtBfx5eelBqNCS9afKcL8xPa+XL4+3iuYAZElUqWS/q4IyO43g
4gJX1pKBnE0KJmvwINNeBpSzSbKBaQPbdXlXzd8FiQBUIvT4b0KV4m2Uo0kWbaJeHphqgrM15nDs
EM4qA+RmtI9E8wHicObJMPZjjI0rfyNbXPxoqwWmMSUrPo4uv+LxtHp+/KloyyJynD5iJL8A5crJ
DA8/6Xrp0pZEOTYkt3nuJawnsDDwKhqcK37NWiWPl0CzQISBviiZdmJxMNVZI3bQ8dimnf35bD86
msTZD0R/SmIJH783eKN0KmuJJ7pOuTHv5gD/TihG565vs7FNGF6pu9mTRxAxlfr43dtLVzWYxffj
LaMEAwiHXZuqwMmaVgIOjRkYkbZfW2eWhYKv+FLPQt608Za7Gejlyoh7uhVqH7wKc2izTUkFNrj4
SM1kWRi0LbyX4FwaIi5qn/c5zy/+goGkd6ZqVPZkSm61EjHZaxhUpZV5n/6zY2B853of/VoV80qY
j0+svwuryJTN9Tne0g7R4zsb87zXZhqvjPpmxP6hbCgu6gWruxSHeBxFRZaIA2zPDnxYwffwUG2O
6i5YGZahKpQ7lOoI81m+uOOyom560MdmJ/ZX12t7mpUNQClFWczjiKCIREToMoHLRhlpVG+gzaka
QABvA6iMiXr3keF9qvy2a8bJLNqD7r7dGQ2JShWGAIhNjP1q8FGdQPS2INtS62moPz9e2v1A9M8C
sX+pFPYsmyfZiTvmB8ZolgIatTS1NNoyiO3jSgkM7R6MwKdRirddgXJn0wwQ4ZSVB1BdqzCQTnqi
Z7r6FZ0f79N/cLT/2ygSjqG1mJMZR5jYQJZdNqYnS8ispTHSMMrzXtwGgH92iEDqBR3yqizOUCNg
nyNT3YL9h3I2Kd+c5IiEr6li2cCrekPTGYy2Dday2FCM/IeU7d9CiMgZFZ00VkqEEGOrTgr8MwNy
w9qMnhKXdjznaP9oz4igCf7/VEgbPA2j9aq1JFsVIFD3NoElyaVVxe4Hzn+rIgInVzZdH0khunrL
11CXj5Sl3KJ+/l46//4+ceIzrQ65qsW34eqlonO8yUk698Q8oXcDopRKtxKgnw6H+Cc0lEHnkV1R
AsJ9RwclNmglAEC4EbDkpU4qgnZuJuo8BMw4iP4CbNTrlWFQjtTdu/XCEhEWMObZJoWEniz/U/pG
hZJOoGvmatgUdKmf2QVuXOTCFhEhlDRL0rDDqkaMvfgGZO4MK3GXv88CshSe4vuzEzwwRnIVoDbW
oxwMY8Hi/5H2Xc1xI022f+giAt68FkyjLV2TIvWCIEUS3nv8+nvA3f2ILmK7YqWXmZiQphNZla7S
nAweADF4/dxWjd03KzJlIfTSyD0YiOz89HsKyH365+H676+aB6RCZ6yFOflOXUuJrmBAPyD8tQbL
St3xMUoJIqvrROYf+XFECyLUfRRFWRXCgDhH38CRbh4x8/FvFGgExorDCFLgI8QOnrE9BaLVbHiX
ER6uXvQ3FxJ1FVLR/nfUe7+5YzwPV2958dNUhCuOIfo4axyQ+NRvFCD/yy7jnlkUJFzRInQqmsKI
MdUKU4beusZ+8O7/kQXKLAMflUePDAgkt53ZWzbHWluwbqsWh0RZY5WX+xG7XuAs7fT+LTdve4s/
VCaDD4as0uWuxKiA+SSDynj3DDhcRJjv/6QMNFhXYHCN0IogEJwnN94ccqfaXKew6rYWB0Xp9Dg2
aa6ghHROtv4jT0JmunmW9Cv6LFH6rOcFVybzO0nePFWWtNeD2WaEFqsoyGCENq2a3E9RXEItyhNW
qJ0zk/UyX7lstBsp82pf9K6go/BSK9LSw4OikXKELXiZ5+bokMxnSdRacHRBZWZzqXuYJTeKClRq
W3LeBLKNtwNKNSMrvF/R8Qs6858v6Ah5mQ38zA3e/9v5wEaW7K5ciILmJrTQAzFHFegu+ljGwie0
2OV4iTtignbWoWQY8p9DrJi5WZKgDmsaC8CscCDh/W7t/ummcOrHwuYt4cmM3wPC0PYV93dBjToy
o8iFqSnU/AzcdocvTRnQGR2in+rjukqy6FAqWYl63yT1TAc95gORTqZ3Yj28WDQorYQP4RS1w8mN
prrx7pBptNA7X5HyfJ2XFT+4PDM60xw3Wq/FMx2r6rB7jJlMWLEu2J6IBzAaQ9FORyOkGk0vCNyE
swqfersm+jbcEgnxIlv91xJZF6SoI/O4HsBtIkgpmILV8GhxAiwUhwTMy4b4X6yEz+oNfXP25eEW
ClpHUhtHM2cKMRzO7LAo3flkuJd1a7MgQoUpouwPbTuASEyi7X60pxPyJI9312WASYWKWEalMbSA
B5XSljfHeF+a/qPw+Tj+YhBiHRkVtwzFhG13Mx2FtK+Cqz7Y2e/P67z87LbC4lh0XmMDGrpFVYku
Bee90Fe9Js9PZO8Yn4rtuEtP3ubsAfk+PKIV4vAyPI2H3EIfhH2d9tdvU670gjblgXy0K/ODCtpp
YCbvlRVadWF3VhVsUhuI+G21z0tM8ldYqmuhFbzGbk/J5O3RBFjI8JKnM0hIuMeYhvyZ7rDHdSc5
SU70iqRH/SjuYpn4H2VMqoikbxV28Y4keu4PmW/5ntv6qSkdk9Qggsu/evqGS5DD1WMzGF7RdRhW
52badJkdJdtGJZ3PqIuuOF+gWgDQFZDI6OOk7UiXZQWSBgJev4JV7CeFPIaWdf14WSQoXeg0PG0l
o59z4li7rB5eH1iDF2tR6QUXlCJInKiOYsNn57wiz6UtYgMjyRSc4x1rtnfNWl2QonShbeRcVytw
U9vRtkjMZ8AgVmaZmHPdRdumDN+4YucvyMmX4YQRiELnpyC35z/QCsVairNmQi5+nxJ9WZeTZkLH
6Hm6QZVfQ0dXYGbEfcpd8f66GKwERheUqJiiROeC5AugNG5E81hv9D/uvxGgwgg5VqpIUqe5iMSb
b+ptxWBgxQpeMECFD4NQ51kWQVWQGt7KdpWQV/eTcd0sXaF8YdmHYt/GEOQQM3fO2Nqj5LLyTdcv
4sdGzSr2KjXXQKP9POYb2SqePEYn/vWTAsr8pdDG0tToHo+b8B5z0p17g5i5ZTJ8LIsNSue9Uu0E
vQQb+w6J+sf+/wpGNmM8/Mcw/pjASYR6kEoe1RSspgpJZN0bdsyaxGCxQCl3iyZVf8Cq0bPFoyiZ
WKXVMTphV94KF1xQ6u1xgPgXktl8hDv0CTsiq+2cYUCwwfTyroc4rEXPAwVuz++Oc9UEGFqD8+hb
rNnX67qh8pR+88jRT7WGGylLohPTRydC6TLt+0oV7eLEKC0vcuBNxw3u5BlvKxFeXjPLg/a0Y4RU
1+06NjtdHhtG0HIpk8HMedsQ1iOEcVJ0iAuplo0owY/zneVMJP0Ij1htxnokMk7qSzIWgXSepnLd
B7CHvSk5v+e5SpVgiQPrucswJl8l9wUZT9YCxcshYApxHP7BfM9thtFdpSACJg2ryrC8/cdbR9WB
j9BJUBIN3VT5RJQ70r8zoqC13mrMZXxToW68xrrp0DdEKIqrEatO3BLZB6cBrC6QsnPiobjdbXg0
FecILOKTunEbjOK3vz7tV/5mx8qjrpqe76+hRQSxeChxPHjGlpbfpfWC/mrGqa4K4YIC5QSAtJ/7
pQcKTUMMk7vd91DX6x5/1botSFAuAMOQRSZmIPGEa8OOWDP3yHUKLCaoaC9CcYiTG8h4UlnYlKgf
AqwrNxmiwZC/r0b0hYQnbVCKfQ8iCgk6UuPlYWAXrWbl5+vMsOhQzkBu9TosGxzXaP6uJsfAUIRp
K4/XibBOjPIH1aCHtYpbOe+rg4PeRKt6qhiWhyW7lCMIu36I8x4ktBun20cuy7KxxGpmcXEftarl
RlnjPjBoPFgNUIUfrp8RiwBlCoxsQl0b9v88PTwr9y2WmV7//fX30LdifD22FxzI2OcTpzM2PUD3
twZ5xrI2grJmsvOd65QYV/E1KLgg1A4SBno5EMr+5OQGmh6+M3RcYEitSCl5zbWt2gq47dJuLMHh
TQV1Jay7Q6E5xExpV5nanV2Rh3dWMzxDkr8m8Re8KXLQzjOQ8yEKVh2RX7ueKO/Xz4/FnHwpauNU
FmNRgka07W396Y+w0TbTx7/Zl68K+IKRQW+NItNApDcV7MW0LcF8qU7/SITSe8krxwSwK9D78gkG
7JRuMXRlstpz1oZyll6UnjaEg23GbhY4azA2GIftzG1zLp9jR37byy6L3E+0hfkVsFAkyhREtdf1
XQ3he+4OgmqHh+MZU4i3WCvnA8FaejLNYbDApxDbn5ge/cvMxuIDKFMRtX6iAAhgFsKj7/o7+UEn
D5ql/82L7ZsMXbqVu6HPgtlZP/Ob/fjVpIJJwvzturSz7BJdvZ0CLStKD7c3wDWgD+791TOzDUOn
1qoXy0v7isQW8o6VZ9moBTgz9JL2thJYnm4hjYjCUiAeI1LAerCwY5icUYFC6IUahuNwgFaTkTwi
r8ijhY6LrSf/eISUxQj6qBzlEEeIV2n6GG5+vWamdsvKqDFsH12TS3hsSEsF5avldyD+trP5+39k
hDIYGKccUmUAiWPqOk70ntWOmTxfJ7LKBgYZ584aHWurKPXVQ6McqlxHpAA055cc4HGqG/6N4VvQ
oDS0iEOVExLQqEQrBlqusJOfxz0ribrqKL6p/PDopaKgYK3OsVv0It2hD39u9tUYvKy/5hdkqKBd
1YE+oSF+O1vYSXtrEBkrzIRdc3Kv38uPHYmY+sHQ+H8uhnbqWNmg+00OOnGx0Wztt0dm1DFi2sDQ
3O5O9XkfbTlH39VEw4uoAFAvJqoZT/D1VO7iIyidzYEVqhbhzKyY7/07bA5SH+BDfgWE26QWy5es
m4gFOUpzp8DDwOsIQdkfRUzLWkI3N8mIGxZbq+/yBR0qzA/TvE/zWpufdqhMkOfO8nfT5+f1G2Ro
1tfunIWNrdIuCX0eRDCGVj7txZ7gZYRhlOtUZhtAFWYuxISO9Acj8ADejJYcAA2RHjto/irWXxwW
ZSHGDBvkym4WRGwjtTDc/P5vHFDWIRQbjDf1+P0BsyCnjNnWMEe/V06IdtwYAh/HWMEJfZVpnTff
Drfma2Sz0BDWJhuWV0G77qAXkRXjwMjc1yCaNxNB1292XzH7/xmSRXvvblC93PPBUUoA/Gy2JLh7
ajEkzN0Et8W24jcdqsIY29HO12+KYWHp2XdO77O5DD2/wo0H7qY7Ay/AUQOLIdKr7AGkY+71Q5M5
fY6YP6tgXw0Ynfap2cfbx9hiWvFVC7CgMQvNQjnHPoy5vgeNvbrJDvxOsAYySubr370zdczvAq8S
0FE0+gFgs+LQD8Mcd/WUnAG4/OSTEJgpcE3XL2f1nbkgRNk0tUvbuuSjmZCGRS6YDmS1Ga8L+IIE
FY/4mTAJyRTPbUgCotPRrs2PwYQvtwLCyjKvytqCFmXXsIp6xHItnFsXmyeg+uEFEVoGK2ZY9zgL
MpRxMyZ9KrQIZJ4nazrcqjft4S5npPnWz83ggR9gQJqxruBS2OpuGrEIIptbHTonf+1fEZeatTVi
27IjWkyRmyOQHwbvm5w2y/5CtusIe8I4vsjxmJ2c8QkoheR2Mr1nwWZ4uPXTW1CiYqHSyIwuUkCJ
NwPzJrBkUpAUDLGEYVW2F3QobR2GrOUk7Iw8W1i9wMHPcYwa/yon2rzrGeskMMtNF/nbXu7iPq0g
bkCTVM057pjTzexO9jV/vSREHVnmeYOaetjxiwHbU4hVWV1lNYe3gZSW+AcSUR/Kc2P+zUUtqVIH
yHONJ08jDlAi03OKd2UDkPkOOSEWofmHaNlbEqICxkHouGFM2/ysIS+YvMhmTe4z7DKvTsWOkSJc
VaslLSpaTCLez5oSd9Y4iOBGW5i1yqmtAtaCtbRizRwtaVHWVRlbCKGKa+tmtFwXkxy5Bbh+67oN
F1jSMf/5QnW1WjIKNQCZAvXOGXUYuKY32FQBke/Mxsb6MR9mkAkLxyJLGVv0yApaY9SzgZqcaguQ
Q0t+lW30Ljd2chp+C0+qy9rS+3NxJx44yyOlTG+coH05Bp4hNGHKSfs02pqjOcZz/xqYPgplmm7y
ip3eMkeNmIJD2eOwkwZdqcBuhVPGAJtZ7AEhA+zYYsMEo5iF8H9XiB+bVaQ0UcVEngXHEWfk9IMj
HFQzVWwyPrCkZy2o+T5RgC1dSg+e2RHXYEwGQpq8i7ZP/vRWu/X2dwwpnX/nGk+UNen7om/UBHSA
QvSW2oHz0djZScQSCWZMzWKJsifGFBd+n4PU5Mgo/2PBEArbGboemcHN/EvXmKKsicLJIh+UuCgN
q+6VvnMk6WOU7wwUHzPeqhBXV5bauX2zMdrXsuj+z7DVX+ogy184agA3poQy0cKwCupx7iDUUBOS
4Ext7J63WHq35kuxkfV/6Hx5woWJQcStcH77Raf+3TuCnW3+on8UsJlAyAKAug68SYoVTpe5JtGG
WQ4x+zjfGXdUXi3WZuvVVAyWvWqo1fMixsIoC+L3Blf7wLoFWgFvOhmk41bZPMbOO0Pe15zakg7F
jyLUY9BpoAMc/T/YsUvC7egYGwHFZ99i9fp/XQAtiAtq9AUNoSynnghq2CZM3ob9n+lpxzo6cc0s
LYlQpmLy+qoMZrPUYzddSqQ/eM5Z6kiAZWTd3E+Wg9frrb+VZXv4jNydsWVta1ktUyy/gDIiSciL
acfjC6Zup+T7x/2df2oJT079FmGXbl6/wzUPt6RG2RFvamONm0BNAeoAEhntc/N6ncKaXi0pUPZj
kMcBQgqn4r+it64LTG17ncDPZcuwEEsKVAyiiSPfKDV4qCxxBrWZrAx94BpRtil5Pvp3oZmQ3rmV
fWt4tK3XXWZ+sqzk2tN8+QlUfNJymjH5yhxyAW8gRiJXJJ+shQEsGlQwooUpdrnMoVb7tC3sxn71
LRYbq3nNJR+U5SjrrBl15UscNKw9PaOL2PasDt0mj/zeuL1+cSyGKPMRJLyQp7P5kG6cmcxgjih8
XKcx/8YVo0Envxs/9+qxgZ9EIkh8lUmK1W3YrWBdp8KQcbqWLY6TGA4hqPQQO4A7T4F5+rxOgsUI
ZRYyeah1jsNhWSGCXRKbkxmjY4rVV7hqD4AXqauALpQV+kluRIWQ5x2fn39LzrSNb2X3Ohur0S0W
Wv8PAfoRXnDY4hyWE/jIAttRd6o5AAQiImJOKnj1U1aZzHVpq0Z9QZMy6pGU+JFWwu8CEd7MiYph
7Tm6Va3O5B2zvPlXHqm7Esu8qOIUh4j4XTY5LEUUHxMnNtVzZ74GNrfl5wHXbsOQwnUPCXB9UYQO
SxIt7F1fSADbFJB22HRW9FKbAU/y8y4amPWPtfAT0Lb/oUSdKCfDGI0SKCkiJL5xFHIccmvatCJz
nIhFijrMXlPzQQjE2UM5kRUfDztA6LOrsPPP/DAUC44oRwg431BPJdxZHbtIF2Pps0zkP4Jt9pPD
kg8WLcolIqDNiigBS5PTAXE8CgApJ5n1zV2IERVWjmi1pr28K8o91r2SpUDSxKgPEJgkOz0YFRIB
zWZ+laBlcJ+7KJeZwea6oq/aq8V5Uh4RqKxDznegKumbun4q2lu92SiPfPLIt07Kk+vU1kPer31f
wFxGcpw60rjQeI6PJbxSbrYO2u3642FA99jfVGyRFcVasf8iQ50lVuAVgDaU57e5QVqZCPvit/rG
0uNZe37K4jcV6uziBtDxgg9m0NNXkuB5HgY9eER7Arrh9XNbv6VvSlRM0fINN9UGHj28ndofCTnM
T0hWjMm8nDkQWDytKqNo/XK+HCs5HDMLCPvw9JLNUqt13/XNzMzsgkzgaTKnBiCT3VrOYLV2/Vhu
+YfhtSeRWVktI309f/WVW6LrZ1yClRO5By1+njJSnAp0d2ZMjKkvm/2Diozl5QAhnfdLz+ZxwZTA
AXw0KCFxM5Se4DyHlvnUhmbsSm7giGd05m+7+8T2WEK4KhkLupSFR/uDrBYJ6FaoaPwuH2/L27vr
srd6fgsKlGEv0MUYKTUo7L0jhg9N2HXGDbF4oGz6iG33KJeBAraupK5/GjzAw930tev3fzO9ixT5
9z1RBkjJKn8sedDCAJ8l3PMk29yxpg1n63IpCwDxxng1ANAVrMegk/Gy7DdJbsjt2dqy3Oz8edd+
+vK6r1/sz2j48jOpi1Wmdgz8SWqBqFI76bF3TFbBlXUQ1MX2gIDufRkH8XZ/y+pLZf02dZHq0KRq
q+G3U5O5J2zlfXV5NLT/8A2uBZh2e5as+9oCXI998OF8H94fnq7fwcrMwCUlyocUsIRcNx9RTLZA
Le7JHgbjQbWIYz7cZ5v9bwv6Zls2Rg9tRkfgVyH6mjBRXsXDRGVcdRCAo/O7fwwfdTs1PwA+fbS6
m/vAwrr3remGD7bZWg/uKbU803eM7fv1E2DdI+V0sDU24rsKH+HcIzfK8Js/Xc3l6VKupu30kR91
/PhAPlhavpKGX/74jyk7vVWU2veV9vwU29wp3RRvCQGGe/RocawNatfVnh63+5cDx77LS08lCt5U
KeJ84LeMq2R9JaXuJVd7XlhClv/5l2fKC+/aTa1keLOpAnY0q7HzugCqNGzjyPFp2I/4aoUQwsiK
r+QpL2WEUu8sTpvQmGUE6Pf3tWGL+eNdct84SClbh/dDC9zQcX+QnhrF1I7BWzCQ6BCxoPi/eu3+
d0X/MVfXC96o6bOOYZm1KZEYWxedw5zXrknmls7z40g2rv35j+JAafaoaVnH8TjYgZiMn5ZYokYp
9lCg8TNW8dt4lMUlie/yzc6+OYzk3rTuWnJwX833h3ZvbqwZ220nRVbJimMZn0Dlua/r5M91S/qF
nHyF5gsBDwMB4xwT+Nn/bgkq3JHlHL1tRURif2ALwHVq2OR3NYxQv0zbglwvGpPWJxDLkmwtg2wH
i3uLyXuMkmntcmRbORgrTEleElm24tMRDTLKlrO3gbPfjkhviz6R3m6U03OTma24Pw8A9ce23NQ+
KoT3SWn7he1Obrt5rjc3Om9Lf9Q7AdvdNjJW+G6Mg4R9eiTQSYjlk8OuBLIF0Y/CPVBBiB+gLTXZ
tglpbtVPAV2UW8Av4C9MVrgfsKkTq782yeHXpxShRK+fKkt4qDMruu08rPC4zw5FY+dPmpObDT6X
+6O/KtFXR0SUkX4jOdgtWpv5wUNyKd0I2PdxvM1nvLSPI79tnE3hfBhEwYTrFhUzk9+V9rEH0TB2
BytqUdNGSkN54+1pP9yUpHu40e3ARCIbm8hUM7AKJ9LJ87YkWDANb5abww16eB2uIVtH2UBSjRQA
p4IJ2GCJvB42LrAg7rVNaNuajYz00bjz90WGMsadvkttQHv2ToHSefKmYIPeREZrEEzjQ9uLW7kh
SoqK7+k2sPKBbNVw7ptS90jQ3TVYr9l71ruC6QydlL15eOXf0s3uV7k/lZbydCN2dkcesD4ts1Lg
PUlbzrrzdsWjdlYKAsRVQBpjaZDNITTeAHBYQF1DPXW9Nbq8vW13j/lbWpvKJrBMvQVuTOhoJ/g+
uzG1AkhemGtDiwZkBMsE4gnZO29rF+5DTyRg4maf770l3rjvj/0vRSIk2Fnqbtzq9xi42KFb1iXV
h9qTzU6F8E8caY4myRB5mDJM1x+saDprEnEqrK6IPjTT2EYntLrcEPuhIoldWrEFpK8OO45/dWaH
PU672PpsBcBAuRXZ7qSjOd2dQocnwn31GMACnhH44j6602mL/9npSTHg0JC56vAtlm/i9F31/aSg
M8jU8aM4Cc58Dqzsbdo4QGfP8J+CvU+Jg11LvzgU+989O3/rAXGdoDlXJr0VFraR2Cf3l5l8yJub
fH9qTXAKQAkNJeFNiP0o52Jj3ArCPiGtFT9+wMuNkPyDdwB4bHF8x6AokQvyzrsiqd1Jc3abZJeT
e+Pdz0jwGVrjs+c8ardYWV08tqi57nKMHFtQNJ4MNvL1LpE2uy2XWZ4PqQzs1syOKHhvTOX9NTaB
Hivdz7A/u9aqa5O4CcHR/kEmlNuekoaMN/U+sauYEHdrlwCJNyzMTPu2eMsh3olvCuKOpoez+YSt
Ah4pafaP78/pzVPqDHfBMXq1ssGZXB7K0CbHnQr+rxu0NTerAMhI1mRJxpAvbT7VINI4LvQ69OBK
DlR/IL/D09yQkVhNSvQb1Zlh4I0trmoXou+b4Y6Y9KmYSphqqUpkowN8pJCawj48n50QePqtg96h
23xbIHKWbg2Y0ezIeEF88UY59wveqahLTYOIz3TQLkfy+2wAxSA0PYIspXv9kFeaezCBsDjk2SEu
nAbP+xrGwbnu/GyF9hGoN9KpfIayKFjnq7FrXD+za5fkqDeYrzfJpFa406Igv16Ep4jsBQcKwGJr
Jf4DWxJWqkiipAKi7pItsegCsfP8/mwQVPsz3oGFxCh9fote9wh4WOUtE0FupQIw8/ZNkzrKuIza
1NdBE8juWQA3iN0uofPZM3hjhSiXrF2/ftZvUZ88SLkYdQUiFOue8ZU/0z+XsQ910YFfCxXWuc0B
uEFiWzkpAO7vSc4gI7LoULE4IMhyrk5A59kBoBohxxvO/H08+zZcHXGxbOlpb/Pk4cll4SuuSNgi
H6R+1doWiuPHdSmk8+sFxSzW64UVCdMDUJo+FD03P1+e9p3jBNY5Qh9JRn6dEYA498S1t8pm9xQQ
E1Dx76O58y1Wu8xXDzhlgS74o4JxTxaTshnA37NlHe/fb27ckrwgtHT2OUltNFE6DuQ8N/fd3rOw
agr4bz6xJhRHzc/N3WDaD/ZO3j/ANZDb0Lr/hLPe7j7cjxMPD/VLIsdjgBDM1e3rEv01SXrlu+k6
HGd0NQAbEAULzo1nHbdHq8en/nYUt8azAcNqqSORAzYY5jesCj5Dm77eAwuRiCYBy6jntE9q2ixx
k3+W4i4Uih69UvsgG8r5MWGdfXLczie9Me23M1piAoIwLbNay3oP8RYckdOZozXFMhFaqQRPJ0Zu
9wvG/9ohX9qg/ycVasLFIj4Gexes7fP9L/9O3j5vjta2NPXbhtjuxiQP+DcmZ9BWoNo2PtDcuA9Y
sgmYDJclrQxlpCtQXKDpajdfOhAVWa545oXm1UD6X8KyVIxM/HAlweinTYqluXiwVALCoP5ZdzEm
yln1nnXLa9ZsSYuyx0qAvjJA2nWwmqHduX888jDf5XUVWQsusKr6myPKNo9emMaDqgDhyTzG92+p
mbximoGJAL8CAQBvuKBD2WYj0evcUEBHw4Ovt39LbxVWggDtNgNwOYeWfGw5JfbjZ+VcZ5B1ilQK
tK0jVHiTr1Pkbf+3Bt/zoPWE1RTHIqNfxhhBZIxTWIA9K/GIlBLvTwqhSKCB19lZzfRgUAc7REXj
a2nhJSEl0OLcG3TEaEcBw1vwB5XL4cUZoDmowisitXynd7Vt8jEjLJQMZV+rKCypU7ouFFIxhuVM
vb2/r7eZ/X6dvdWU65IAJfRjUldCLYGAkDrpaOWaLXrmi7/la9t4Gj0LV8daXPS/0AQ+pCZqAnad
U3fHT17MjQaU+mgAnkjdRUiMN/Zkm9njX3H3TYnyoxy2tbZSBO4s7ymarNrC4zW2WpfHhXGMzORq
Cmiezv1vtmjnBwjxrOpCsFVYCumxc1Ig3pbHpBIg/DWgEhEGc2tOaUnvsnL1/2J5mPxUAHPJy+Qq
p40pohAb7PyH63TWnmKwJN980U8xL6g9OcRzCImU3JUtqXM4u9ijlULcp1jQlRw9xBV41+8i1NDV
U6kRllFZC+8vvoHSgwDbX+pgvsgRCaPYblz9INgP5ds/HyqlD17EcZhOxyWO2KGD+RGs0nEe9dNf
TPLP5vn7UCk3EIliaXTjF0Mzil0KoIXewXatDZOjWZt+utBvSpQjCFVdHpMBHM37Qg1AZ3UYT8f0
3GmenvMQK0XIU4QYqGRSZgko5QoynqsMQ5j13AF05a1qcRsfFIXb6wK67gq+GaTMSSQHGRf4ePql
mBmJNwkwl19DZjeROIvYtXOkbEkr6QZWLuHG5LseGVXs/DUBIIwCY4HA1jA9JwTU6KaD9dwlR27r
39Quq5+PcZV040XC1anoyfCto1k/ti0wY1S/sNTA7rzP//OZAt9WlUURgRdAbqmrS/uxqHIOzHbO
cw2QsAqTBw8s37qe/1hQoW5ObY1p8rEN/PxkkMCMBzIAsdUntSWiSSaxQ8d/GN+YVFcu8oI36iLl
NJHkVIZYds5XTIm3qmAjF+nsmJs3Vi5sQerHrE/tiaFfzrqXEh6zsYotWg+sFlyJRYTyA4Kqlr4P
kEcMVxj77CVDnqxxZbu8M+6nu0SfR5jR72YWCFRy97O6E90DrHdGdo/IkVoWRlAtoNdYvGswm+zX
otCLA6B9R56OWTbfMM6a183SNNDL8+Ydbj+K/a8CHYBEdUfCbUcPVbTrIrzmMxQBzaCGjOEZrH+n
aGcK78dRBLswmpgF9A6H14IZHn5NuFNW4YII5ZjSPurRDwoipZ2ejJN80z76O3VbbhQ7vIsx0zv7
xFNmu/sBqfDPFg1Zn9kdhxQ6GTFowUperD0vLr6H8l9GrAxlreF7Kuco2rxMNoPdnRo0aLHGy5nn
S7mwlNOKVq1ByvLmOkwMDOTHB+OF9WJaMe8XHFH+i0e/baIEIHN883e3OkSmJ6p9XVZWVWghKpS5
E9uSL+URNIpb71DZsnOHNzwjlGfxQRm7WBUin2+QfT1Gt6H9h9tUeIL9jc+9OC3KuGGMR4wqHpyU
dm3ndmujCRvuPWUvVF4L45ek6Ib2xBcGBY63P2NGmWh7ae+j5HbKneaxOLL4Wkt6XBCjjJwxoRda
5nB6wo3wzMOQHLcaqp+C5WDY8Le8G4/+LrFU2BPrpd2a2avi5iZnHmxJJjBtHjHL7S44SqhDoQhm
e85p53Yv16VoLf118ZG0xQk6sUjmE9EHDCv8CiUUvzDrrPVO3rmBumklkktWWG2AGR8JN+FIJsUM
JrPizSS1vQjFIzTOj4UdBVY07ariri43fPHA+Mz5M67YLI2yWRFOUm0alB1409spv/z98FX53Nj8
HgDBbkRMHNDbewlAlNB5YhBfVzVVkzBkIWN7DXWRg6qOSh7gIkezf31GrbInDQrmmRXu+mOio743
mcVE7PAs38BztfjTmPR7wyosxpfMlH4cA3bAqghzdPHHukxe5CSfw2ZJBMZRh0S5gDI4qrcf5fZ2
cEOMMr2g9vYQEXmPKTiLNdS0bqm/iz88ZakzqfKMoMOzSmrN+AOLR9MtlPSBweWq1VlQoYy0Hxeq
kPk4bt6s3jkzfkFWnoWLu+4JFkQoE50AEkrUIxBBJPGkYkgnxGuwP/Pk7vqVrWRDlvUyGs265Uu+
kgvQAebwvfgg4QXoXqewbtQWrFBWeqpSPW1m8YRT624+XhI3txixNfO4KBstKRjtrTLQGLE5Q3CL
fber381ow9qDsKpq37x8fcciJe4HHWpmXxIG6R623L3qdMhRXT+xdaOnaJKsIkEmI0cLNVtQCWU+
zNoi7pE2BbaI92TEprRHrwjCat1JXPNlfo+J6M6SkSVQnqrNO0PE14PMxRdQMi4Hid9MUtCfn4eM
AErQ33V7A50L81hdRPh9dtRPwKHE5uVsw3xNrBrTBXFK9kdDkrkhBvGhxZD2NiPewSadbTOM9lpb
K/qfNVWRsfjUMGSKyTAKWilQqh46JqNToQtxpwDTMIcMu9iOoSvvSqJMVvOrjUh9xhbBfVHCbPER
wCLVX/ED/ukWrK6xVeuy+CiKeZR6tElNOsRN2NmUxKZ8fgTgf/3ruoitK4wuSBhwEWRJ+NpFsxAx
7JrJwgQLRM7jbkIl6cV8ZBYa5uP74Qx0uAGeVzFtYFA66WEpwhB4w8xJ9qz+3st3yY26He6HlGTY
1fv7jtVIu5ZPUDASL+E6kQeSNepCc8yvK5yX9OfwM36a987OmeXQPDi//pxQxfGJdhTuJvTdPASb
IiKMI519PM0vsEtRh9BFVZEkKuIdcz4fIj7tYUpHzFdU59gGZuWBx/LWYfPAmlQWZiNwjRxlVsNc
KEI9LnvAzWA3RHlyBkD4e+i+MrmNwoJD+6r1/aAmYq+ComlQF3pcwM+qvsx0yEtlDU50blLT10wV
1BLXNg8vLxOCwfyFx0T0O+NY18RIXFCmopvGm7w87Or+v2Dx0VF1mDMbWIH7LjoiKZHhY7jENQ1c
EqRCTn+UvJxrwWrgkaN0SIiSEN5pWEZ+zcpBVA1J02apUSlx6eJpSioAiKObTScS1gGWmVnLd2mB
Hcb866A7KmeYGLUzDWA95ScveUk5d9Reo0AkXbHLBbQ3Zl1H1NwVAgzz84wPXJn1U9Bi/f2BlIDV
Yh5KxaxNUCXNiXc+8Y8fHiAzXnyTd5OSDfu5FowsKVIWQ42yTtJ9nLwE5Ltyl9SwyrU0dyFy3rOq
bk/T0UBBKDA7xPjAo2Ci2q7FryJsIm+oqqGoGvUBQchJ2hjhAxTgVR7uDQwVDOaJY+Zx1y3VNyF9
zvMuzK/eV+PUzDL2BGR3DEU9x0S2DSd7EIBdvpMhCdbpVdwXZpuRaGfcNkdWjmutCofr/Q+v9KtB
6sQu5kt8wn7GM++2/Ud5LH5l+2mTbl8xRYr19q4d2W608U6sRNJaGCXKqorpSkETfwDiToknJkkx
4kn9/6n7rt7IkXTLv9Lod9aliaBZ3Bng0qQ3SvnSCyFVSfQuDN1i//seVvdMZbFzlDsX+7CLRqNb
SCk/RjDi8985zZQ1Q6/f1X6WC8PhOL5nMmbvktg5evAqyNiLmzLzplzKBo7L8gF5SRctNIp/LeVx
+cb8FDkvV4VaU3dDN3YoRNNtgShsapYNbgDYHu8VX1s3b1cLfxeNzpnImXYMw6wewhRG1p9ozfgJ
jN3AHMOoMU7NdTCYi9KoAZJUahKH2LM9Vce8BUsJgUlfLxLVK33AH5nHbide0s1wJblzMZpDrvwf
wuYmJ5QF8FM4hD1ayLWgNqyBvkkHMFF+zRO8mDU/FzXbRTPJM2DV6t19uBTfASAVH3RrzasF/mmC
GOW4/oEuR6QdO3ml0nKpxAl63p+rnFkbR+aD2RUQLRaWe0z1QAgXfRL5SaAnA13h15yki57fucDp
HZ+pnqJsigx8JVOOKdWQYoSCA8yaq6B18b9juak5EfoZtqWbM1c2Q0w2FA6dHEBAmaCdaooheu+b
7q/i4HpfwcVAE44C0RGD4V86O51GZioKEGigVXoDjcC2VNrRVVk2Hs0CHMhuKytH+HVhAYS0DZuk
cUXONAYiRFuaQSh18WEolvbt8234wYD8F9cJI7f2RMPs6D9a/s42XB0zpdK6rL/PEbIRT5PPg77J
DbeXnevE1cIGpkz+ogKAVcNkjX2bjt9k5jbGKUeJKH+mr06OnnbavOXaSS9dfXhC6i7gbF8ZH4Xe
eDnaMvW3rHYzFY3hblZ6JlsOfA2oBsu8UpG/qLgBkAMvG5hQznwtFU1VqzPS/h6Ug6n53t6VFWBJ
X7M74+HzXbv8Mn9KmhfmGkuLmK5DUrp2AP+NSYzobeg3Gbiw8PZekniZIqvVra+IvVBgpajO/WOB
P8YRz17W5K1FACfrMeqooccOdTrD24irmf5Lns5Em4xWDQf8rNbMt0p7Y1QV1JDvExCZjgd+cy0X
9iPamJ+6cwmzy2AbSpVhfKa/tyr0qyqhaw7BELAS4yDJZtz1jtuuy2NNPPqsx+s8XoY15lpAzpK4
sl8Bno17uuGrBqhFu72KfFqK0zp6Q722o6WyAQlkax5y25f1yrkaSl3yjaETDdUgGjqq6FwpGp2a
FTUMKfOLj32reOa6Bt9K4NXv7f6623fpVJ+Lm6nEsSQdU0g36eApctvfl4AEs4KnqS5iBx93SJpe
TXJcOgHnMmc5niGkPUenegfedOQRj0ADq8DvYq4LgHfsMr/y4fut6DVInouO57nYWYhc1rJIxhFi
K2BZAw/iCAgFqCKXdPDuiT95RuqqQ0Njs622zE/3VYAq55X00nT25mdzSrqgB8y0QB8+O5sVlWFh
c3VqL3jLfSsYvdd8eW3e4mIO60zKPFdXpgjiosbocJUb9+2ouCiheKDqE664y3bp1mqujVhcdADP
Rc78iEroOSCisLAhIO/jvb948dsd8aObdklW2bc4uKKtLvlj5/Jm96RXShWdnJC3r8GvlNTe+3jI
QPSNgswUn32/lv68FItTIDlpGi6mCmLuX30HoWR1MbRwyUgb5n5sIULtE5F7ygj4xs/XdvmM/BQ1
C4+7IVR1TdpIeS+NZ07dxvItDGkpAPPVFyO5Iu2iuaGAOCQWwKNttND8urJImEkYE6zMh2vLb6tN
6MO83Jrb9Gp/4OVN/ClqpvtlOyhal8ItGsC22a+Hxg19dBeghFYGPr9T1mgauHZQLgW258ub3Ti1
GfsEDc5TYKt68hAF36Q/onWivFq+J9MZ+Ovl/ufy5kEQazpuKAZE5QXOhfA0Evu56Wnowxo3mfTr
Mg/y732xr6rEk9IXQTc+p/bodsAgKzcG2Tud34XIEG4SvqZRhKPsMbkIpee8SOc+r7ahGbT5NxE/
83rvxN9HAJiUqyFbxMAYi4IKkRcL6a4jR5Uf0n4V5lfoTC/Glui0tDTLocQAfM+vpwWJY9vOgcJ8
/7x9UU2vQkdn4J0c/6PG+Jx/tUnph9cx39NzebPXF6pGxVsj7IHNPaAL0gH2yCNKe/76dn1reTfB
01drcD3q5auNWAKfBNTJ0RGzCN8/v5M/nK6/PAd6P9BmpxvUIrPnqDLQ3ZZ2N9w/PyNnMQJAFbh+
4wqtCj3GRtydG7ym6CZol3e1Vy8/wCyOWuT29PlTXAyZptjeNnTbtnBhf919yqVdOWmIzAWq1pEr
DzFmZfRFhJlBduqXH5+LuzS8Mrkg/xQ3U7JCHdXSbCCum/DeendvYmgS3X6B4WmP6i7Qvx4YiCWZ
6+0sL3iYRqTcYpH56EX5/El+dPHOt//8SWZ+SlVVJe0GBDh72/Jf7Pfs5CyAQ3Nr1Vvv4UO8DjsM
tl7rE7gqlfy63U4uRVvUkOpHt5i35qsJ3lMPYriSH66RenoLfJp4b10JNS67Kmf7PunRM1e8zSlr
VICz3A8PBjDulLW5URI3s70eSU/1ubrpAf70VTyKj2aIPIwWJwvnfiRP6cHM0ZzD0rfPt/+iRTp7
npnxw/hmnHGOfQCUa+ku1YWN6k99jUqFTNv52UueWSLuqCZvGcS0fjZ65VrdWNKNDo8g82qDiXCC
HjtUz28n2zG6lme9JMtirz8f1MXyq/MKPLYlWjO89kNddP7hq7owvNM1aNuLSYQpwgbZgqlT05yd
xDAvsqxUoylMajE2BTDxoEUFILoKyHpV0uz0JSFYhOoBksaFj2AQM0/ZjfCyxbVkxUULebai2Wmz
CBhDwzTp7yVzX9p1vSUuT1w0t6+uzVlcXdLsIBkDlzXNsSRznx3kQe7Hg7NE5x58YPfzI/vD2P71
MP18T7PDxEyzcFKGVdW+QoPQUt02at1eX2sWhtzv+nhVNm69KQqvZ26DMXxzDfx7tonShVUtrjzM
5S3G4BHyzibaVGYP45TwK/UpP1Pv9vYILEt+q6EfZH8D41UtPuwVmmSQttiyfbfyP5f9L2zGT9kz
i22OUrVIg43omW+/9nLLbhjxGmAXBuZ9daILES+I3v63xJq65Wi6purqvCbYZ6bR8gxebJateHSy
xF36vYiMpVEEZYsO1h2Nvxm5R2i97q6YyYtB7Zno2YrtukwYGSaz5RwU8M4BiWLwHbodal9Lr6zz
sixTx/CJTVTUFH5V1TRCtqhv8WbFQm5AqSDcZl343z9/h9eEzMw+cULw1TAsSJ/gOQBDgHnr4spC
Lt9N8+dKZsY+k1VljpP2RYIUtq3PPHEkw1IUm2HYWdWDHV25otNl/8sNPRM406Sjw4AyKLGqJqi/
GxvNM675/pdSWlDR/3w55NeXI0ZHZ7mABOr6zS0ahKFDAbiwzK7c78vR75mgmQoNa4OT3IAge0l1
DPwNwF0pva86plikL5+mXMrVbPb08H/dPpTrAMlroSIxe18FwEgz8L1MzhnIFcMPmrjx1yy4yV/L
elv4V0sFk476TN7sdQ2xmoVtDHmCfjet7qF+KUevfXBEc/f5ab+sscyfK5u9ttghRla2MWKMt6h3
QRNCfLROdSu+6q/UIK6tafbenBKdMHbqwMGjTwko4G9Dj//73D9wF85WM7d5QDMkYnIY1I/sIQbd
PMjT5Dbyle9Xtu2ikTkTNDMyRcp0MQ7YtuTjGUp2sW7Q/omy0da/IujitbLAOKap08GzZisaMD8V
lmE1mdbsEK2OlvdU3GPs9HMxFxsvcLL/KWa2ntaIiEhtiJHUtWOP5mhrqZbm/VP2XQTFM1dcc7eb
srFIyn44sdtswysQfBf93rMnmBmSdmR6xCieIEX4g8YLvtCWtgvE+M9XerHed77SWXCJuYJa2E09
bWjspYvwxvbJ+mt+6lbalQN/ZUVzcwXU3dQIOSRVQXSIvdtwlQHG6lq4dk3KzF6NVZ6mkkGKcRff
m6hgNr66uMqAebEP6Gzb5hpQjcO0BoNLfx++G0dw/CyLdycA0/BCOeVBvUfx+cp7mlTcX1Tgz/Ng
z1RgVdQ8MgsIbKeKZbUXq2hpbA4YiVlvr1H7XNvDmRJUM7XTZARZzioDZVHv0mBHnq8hPl+TMlOA
NLHRCzJdZX2vSDQBRq56Z+1tQMh/vnXT98x3zgSuKxKnKijQzNlN6jTBDTJkw71QWyPI1JD5LWgL
l23dOdfe0iVvySQoOQJfGj0180pdScc2V+MC9R832rY39dGp/RTNO9ZSCyrkj1wTnVNbO/Til/9W
gHMme167QyWUEJJD9iI/xscwvmkD+aROac3wWp3r4vE/lzW7ZdQcEu7UkCWrLRlfMLqeA2pKrvPA
Dv1MvTG5l2drzL/h9pHl5+/zqvCZ9yFCq8wdjiJb9RHut77pdUs0GYIipA8EpoSc0xV5l5zF88XO
rt6gpnmLYbt+6sKLguckUDx1TU/lNg+Rj0Jf1kcVetcwaS76debUWImuRlVFDIVjfZaIaewwkWk+
maDb/SIZ0SN7a7pJ62Hy7u5DuXJHLnrg59JmdjUxikwDAQvK5f5wqDHvtYyQ0NiMwzWX5JIeOxc0
s6ysitLMNEskVY3RZ4HuArZp9REGgP66dhmnc/CXi3+2g7OLD55ppiUca3oudxY4CcmrUaDW1gbX
Dsi1NU2a7uxVZWYSQ8tA0BasNe2TtU3W4mUFABV5tZHkktI8274fAC9nosoo0oZ6gKjoMWpAqaj4
V9vkLpbwzmXMLvfA4zzJO8h47LznbXZ4MTCc5CcPoKwD1N0dkmGPn9+wi5n2c4mzGz1GNkjXWqiT
7ZF7WfD2BvBJIA8bcXBP/HQI5M5Tt3eRv/L6vQe+vhNdf79aG75oJ34elzlESxgXmRFq01vc14ss
8qJ1j/T+ahUtvq/aa9MGF/2u8yXPbCxrmMHkiCUP3jNY0Y6mb7oT7ZZ1lWnu2pGZKRIa5kJtGkjK
XD85oC4KnKXv13oLL5C6I9KwpqYKDFAgHTFTIHZX53nDNNxr8iqOuR7Ir+0bgBp3CEBvDQw6rvw7
frzzui2STwv0dLnY12vpxIuv8OwhZspF9EyrrBgP8ejv2S6+0RYLMNqh5+L2Ccm26BqXxMVo8XzR
Mw2TVS3jVgp5tf8Iok4AIH47eN7p2rouehW2Ach4zABTOt/bYhi4URcUewvHIujWgOy6Npx62dyc
yZhtXZ2lyVDlk4zitbAAG+QEpr/THjbAfdpXyMlciQYuZtzNM4GzvXOEw3o1gUD15cVy9U0WoVft
9vZ2dBsv2hTL4/o+9pvIrzfN3cfqVL2d0L/mPXigbWuDCJMT3t0Juu/aQZ7W+RejcfZYM12eZ3Zj
5g2B0TCX/XZYf67pLla8z1b9ww6f6e88rqhV1Ph6nbnRktxtNqvT6XTFml+88T/X8EP3nAkpWktr
mA0hftF4xGcAYMWp/Hwlk36a7xNmTNBHoplTP8lsn1SmGRJJOxz9+NbINL9Gj9jnEi65Xaj1ouUB
8Ivw3WcaJaqymqR9MdyXXbqoJbp7AVcbga6V/ekp/Me3/n9E79XNH4/N//6f+PkbyhYsiWIx+/Hv
/yW5YK958lr+5kr2/ip/qz5+uxOvIuEi+cb/c/qyf/7x33/9Ed/1pyz/Vbz+8kNQikQMJ/nOhtt3
LnPx4ynwVNNv/p9++Nv7j2+5H+r3v/3+rZKlmL4tSqry9z8/Wn//2+9o6cYoqgHIZkzCTGTPU6H4
P87l/fnLh9cC3/M/bwGed/sY+P/rt6d3Lt5Z+dsdtub16le+v3Lxt98N+gX8l8itg6ASJWF1sukd
vufHJxbMKCjuJ6ILINLjxZUVEzE+Mr6Aa3SaSsJfAQRtmhXilfzxkf7FwhitBiAVDLugG4T8/o9H
/+UF/nyhv5WyuKmSUvC//Q7y8V/O58W9OPfJmJDAXS2Y5kVFSF1G6SrSADCSVPW4SkRC3KRr42VF
2z3NlVNK2sdQmr6MtDXg99KNasSZyyQYRBk9yDZzLQN4Sw4/ZA3PX2y7D71WIalbDGbo6nqkL9ve
fDIYB2RnnlabQUs012YDuiEyJwG98fiR0+grUeJyMYx2t1PysHPLfvDUvLjtagv04lkcnqQYMs9q
K7KuNbSYOkID41lX+p3jYDCGOYmM3bZizS3TY9ONwUrtJjLpl0OH/oscvayeVqaLqrfQdCj3vLDJ
wmnLpyyN6xuSGINHbZG4Y8LuK2K8xiw5lIV5q8ZW61KVeUaDbBd++VAZ1mGskkfhJKdU0XYIUfZx
oi8ZHcagyLjc0dZmGAkxOt9GKsSjOtLNzHKWRJV6UHJ1D5P1oYYpYqQo1TzS67tCjrthVHvfIM3g
Fa0t3U5V3+FvvvLQPERxz90IHHn4XMk8u2d00YuOeym313lNZaBZQ7Qra9oHWjt4Mc+2Rh1lXlg6
d1mYryvHPko9wiwFnPF3xpsPx7bBoUanDstsWAsNtNPw7LrSfq3Dfh1mmHLU/Ur30iZFfZk4QRda
R8zofciBjW5aS+GZZVG5usXqozlWi0iC3NlN09zyjVjtQMsdCb4Gf+Xg5uhmBPldVngtIo8lwRa6
khMWhGq/qrhm3XXam1UOqSdjnmyGJL6LIx1z8nYJv5oK1vqY3HNlNaZPSTI+FLG15EmEXZZmGDRl
X90MMal2gnXdzUhB9Ynaj7IZS/6V89hZFjVOnJV/a0ujWYgCJO+xHgaEttbGpmPqs6Yvt1xDQUVR
y6XS9g9c1IOnZcImnl43Xq+DTCxFO7OerxyrOGYpvw+1MYCG81MViB/so5TJIhF4I4ZYNmjbdbk0
UG4AcE+NEkBUr6sIhczhpQFIdSYbv1JMjw/lSZTaEiRSLloatk2ke6X6ta2Ax5P2AWUFGmUjr0d5
Pywbv0kpLodz09v50mI3atwvO7FJHfQZHDJpu7lZu6bxSBK6L3uQTtpAlVcU7YiRXt0VXRSoFvMw
orVkDz/U479lJfbJN1bx6kP8agD+n7QHULv/Wvv/V/72Wv6q7PH7f6h2XfuiYhAYrYZgQwPr9lQy
/kO1a84XoBxpSPSjCR3q34RX8KdqJ/oX6HoUIVF0xH9/Ue3OFxPGyAZtNzwFTInSf0e1/+rjY2oP
rsA0NuwQnaAN4seE1Zlz00iMEJQCByZM4/aUlWLquWxTJajyGmPTZ5vyp1351Y786g9OQ4IoNFCi
EtvEVhhzUNCGFimJhiz2BKvI8+iI5E21mrhxcy6rva0QKRYdxnpBfYl5kjduFChW5pHeHoZ0MI1V
UebhCB1N02MfDlEeRDGXju/IOj0RSUzNj9EFCQALwym2nIii8ooSHfatVMvSSxyaaW6PxOZzFoIJ
FVMTaGFGE7jOQLaAaBUBo54WjzRm0CEaS41TZrLqxumKFs/SpAlQU4AC5xGRk9ZXiJ08s7CO1p2V
A9EjHu3Cxvxj2o1umNQ1+hRZqTueyEL9xcFYRuMNgxU/coztaZ6q5Q6SbGXR2y6liqJ6oyKQUsGU
pWJ5dla3h4jl1RPvw2JbdXV6G5UWS1epMRAQFWhog8YFbWToqS3RFVeRTXPTtpYeBZoYtPY9tbLG
DIQ2ipcImJ/HOIxH0DLADjzbXCqD27JcN10n1ztz6n5tHpGo7pMV4MQwkjlm0XCyMlEWfjnodeXZ
tdJ81VHBfkqcPq98ldo5OIVLlSP4VEeYIEPtuhfM/XPN1WPNftKHtsfkIwik3opiSAB3QgaYS9lw
HnlcBWia10eOduqUqDBWBJzF1LdGTZ7SzjAVt+lkITxDJjbICSzSqsuuNyUQ9Ttmb3Fqa3VyCZx7
jG/HIEAvoJYx8VeX6KxSLPMl7gHw4RZCJ69KwRXA6Y2pEQVmNsRsUbIBcOOdaN8wKQneQkCOCajr
RPbUKwhvwceh2voDUSkDr+yISda2acZ4KaJuUNEr2Q0Pou7KEusnKTQo0NeObRjno8vbgjVeiMjE
p4pjLUqz0vqlIQh7T2q1KgOii87PdByZnc3izvF0Zpvfo1TBJNOQD+p9Gek88dWYMUxr1S1XV5rK
eBBreSufSTeZKn2I9dQ1YEr0IMeIxAuMfY8e3N40uMsqpgovaqwEJN1yAAV0SDqnWBcDSttrk+RD
7OVtoX1kujk1nQm9NNy0TPRHChTah1wdza9pU6W9X1ZObblTdQZoKzbCZreHG1W5jjk0d1Fi28xN
okJWCwkJWaBnRO89gvDjRjc4xnzsziGZ1zSZyNya6iwL2tFALdNJtNhwKcnG2lWE4GAOGKnxITAu
h+JfXGaA2rU7a1daWa0EyAdy4I9qoHh1K2WoY69TB0fxJhZbpAYrtRZ+W4bmGBiGne0tWmH8eCwy
tknQ0VIgzZaMcNKMVo6eFmrSdO3GqTBHYiXitTZtK8EXRoA4je0uf+kGgUEdXdYobIRJYgG1fIyM
986ghdin9WDxRV8zXi3HWEvoxlHG6D7Ou7oL9L5k5YImjfiWx6MpPOTgVGMvBp41XtW3NlxKFkuM
PPNxxMSWmZsvo6kw4Rso+B6FaQ2PVsJVzCW15W3koFPPU1ne3lAnp1owNjby/zQzrD8bRv7vmOJf
ArVj/V7eCfb+Lvav9f8HRnuqRP9rq+2+51Eii/MQbfqDP8y2+YWohg3brMPSoj/wH0Zb/4LCD2z2
FKipGnCdYOL+NNpU+4KYETgR1AEnKiwcEq9/xmPE+UJgxR3gG/1h0f+teGxmRVG/sDDaTRyqo6hn
WHMrqiKQz5vCpG5GBzUIEdAUlXySOdmGLRMLfeTLs325ZLhn8d8fEk0NNMq2CutNZ/nVpIqqLgXT
KJQ3tKKWvSYx5omU9J6H8k535MmuZe2GnfHkSPpNNdhtmtRvQ9FAHSnGgkn6HlO6gznxzIY/V8aQ
B7w1cbm4faXUj9fza7CqApIZ0E0TIgiFq4Eeb3x+5tPIIQpNNQx1l0UdkDJQa3K52WSHOHFi5uKd
lguTxOlK2EK/Z9BCpyzJlixmHebxxoehKk34HCWGLY0w8Qiykq7RO2hS0HV+yI34K03K2kX5HXib
RmO82NI5MWL4BkIa15CxvhntI9SjCEDyuuBdT1wmLCNoZdQ+lGVn+MhaAVQ5TFYI79M2CKPhrdfF
oW+J5SrFiPqbojHf0EoF1iF1I670tzrDoJtkRrMcHQ74YL2PdvAKLF+VJjq5reqlGG3pt2OOKJbD
WvilyW0/pql2akSrnKIwMheOXsL1L2tjJUe4Vs1oES+XauAo4mBppr0IiyZu/TIdjHfgMWfvvCLp
QkYKZvz1EbVrqQSqrQBS3kruuM3yRVyUT7EgztqyreeR1HeUw3uLNOHxPs82GUnSZSrVbGk147hT
kc1Yp134qPVo4lR7p3ebHhukOhHzEXMoS8mSeqFWDQ+iVtk4bfMQDYV6O6LAHBRjWwaa0ir7rMv1
N1B/YrJ/MJZ4f86qqSp5jFRAK0B/0n1SkDUoW753iVLc5E6Y7OCrSM0vHSNeJgkaQbIizpZpnSzb
oUM+QjQqXVMntBNXcUKyBcCghfTDGN81eqmj4MwZcBvSQKQK8h16CCe2hes2qOQhyYplOmTO2hn1
19Jh8OIqDYOGpdN7o14WgZYbNxR5gkCKsfRLjqRbErPqQJUaI8UZJrSruh7xf1T4cS7rfQ7fySvt
8CM14+h71NNXPmBIqW3zIvUSMxar2iyq0xgWqV8Acs9TTJzQ1NYqv7GY4UUaQYzaxtEC1M3fSmtM
XnVbeezi3DgaPMl2MF98qdeKsY216NVCp8dzY3L1LhtYD550C5mSiIbcr9G8s2fSUALdcsbMpWnc
eaVVlxt4vgdHDeuXpg+tVapZIN2xo8LnhZWtlaQufWXQsoCwpPNYbR7jVDPuRWKl2BwKd4SVllfD
zziEoUCJKHfom5WMeaA0A/VU2bMF6eObiuYisGgJdVM4zgq6L3po1P62UkcMaRhRvmACYNNVuELZ
0HFr4AH5DE0KfshqhAdRvGKs6AO76cLbnOjZgaJxeamDBfegqM74ddCt7qscQyD7DBoLOhYXiTug
PW6pJ5gmtZwTLzlabc2BuQUduj1xQALihrHt57qFWXuJ3JxrKPIt7+nR1Fjp1Rh6VgWggEN92Ced
9UAG4ztBY+HOKTtkISpbBjRTR+7qqRCntggNz1DqhYEs81I1O9vtOguoEoam84AnJPEz2Tff2x6j
ahEj5tcw5I8FXOnVEJfgW0pqx+W0TgCx1oXVIynl66gX9UHLbLKymPmUGnr60EQmP3FDhgdkT6I9
VFDiVS3Xgiyyy4BrVD+Wwqk8Vg36jQ2X92VQyhSsWUye6qaud3VS5jd6mrWeVcVwcU06BHqSZV6b
lJjWC+vXtCv4skor8RHGjeYmgxUdKYGfThI0Nna6qJ6bOn4ZCjRqF1LcikEFMRwyhNsCeRVXKuoR
Dva9opOnnqqPNJMF2hEQYO2zvIlXGWG66YEdR7vlhtpvaK5ra2qnIBGBgnzX+tLaarjAq1oLMZdu
1aC7ccu6cDDlkSIVWVhIebNWJlsLWG4DZtVZvjKsGvcaIQ9JXN4YK9Uoh2WDJB1wecIsoW41NPWx
bqiKIfG+qf2qqeVXS6AYvshDSVBgiWMJZI5QqPcVasnYWVZ+EAyprkahG4GqhVa6syJtKazQRx9C
/l0Xg+4Dvx/dHnVXrXp4yeBPt0LrjWpRtTDAsOW3SFHqbp9rSVAIA93sFNnXMjeFH1YR3dtGWp9C
lmdHkufDKuoJsKVDDCO7kdS/jUnSIBdky/CeW1LzkOdsNb8a6u4QNn28ESMvT1EKvjYc6zWAxVKA
i3C4zYh3hoWiVqMv4x7jSGj9roKCWtQvnFEJREydm4qF6DnnRb6RaeeXtUPdIqamazgVwiQEJvus
dsKPpiLtDQvNzlloJcA1cWsWqlRGjDmlXefqaCKK3CqTiN30MXd2Mow/OoU7jxUDf6cCG/8qWqva
6pIAS7tRRrnV4zgDsbg062WXp4VvVVqR+2PRFsc6DcmbMnDVDY1uXPWkvdObMtzEg4UWTWqQoE7S
Magd+R4XUX7gfVEFaH7VFjzvNsziWZAambjhiHAXnBZPjFUZUgUogMAaVPFqSErVi4D4Ao41O93n
YOnyh7I1oSaQUQa+kqOeKkUXQdYrPej4bBt+fd1M71Dpv9IKaQyqjp7MnYVTNMcYjDiHrOvEus3C
nQ0LtIdnkLp1TzH5lrcwkjJNMz9neXdXo8gFasOky3y7HfkhdLJbURDEWkwPd4pwjCcDfgcAMsvy
SO2GrAZJV0WbMTQhim6IA6Go8arqLHvX5Ia2zogWfkirRzUZFmOr8JitNFKzFbinPhJuG+uEmtW2
QYriMeE4pFDZSt/FPpdDwzZqWrf9bYLghHo20Gs3qGLbq0H0EnkkI869vORkMY5x6o/c7PekURpX
Nz/0nIHiMK5GZ4HOqpuBckxu5Bq3fLTV7lms1a6d647PzRZkAkU6uCSTsGo1JTBJJj10jDZ+LpX6
eUz6cNWMVbXipAu3cR+yXdT26VOkJOOC13bjgXI53rK2R/DZOLJf2A1LN2Wv1G8kT8Jtl5n8XenD
sHC7IqoCvai6fRcN5tJA/ueWmN1JdBIEhGV013GtXLe63XkjUfWlA9AqrwqLyKUdVX0j08E8APUT
yEg0vpVW6bbSFONod7bp2cIgOxT5+aZ0BgGMV+smCTXHy/vKS4mdvVPShAuqZOrKioHaZxvJQkpM
iYHc3PGQqMAF1IbKl0YHbNS2KVdtmmgHrc+fsvZ/U/dlS5LqaJqv0i+gMlYJ3QK+e+wRGRl5I4vI
BRASCBAS8PTz+anpnqnqnrapyzarq1N5TkS6g/T/35o21zoRz1s3slev06nA8dKdExf96nrfn4GA
5TTV8TfjnH2q3HZUNX5sH4y/xsqW/TaijML5FrEbyN4QtXxiKMneNcbNT3M2Y+GPtwzVn0bJb27G
5TnFVY/TcRguFt0VMvAgEDhCNEQMG+u0jNG3pqn4e2aFwKSw8mKrPFJvjezoYx11/tHHawuhb7XU
5UYZtL69n+G9a6S5pFxOgGDkdzYKDI+RV2WcDei3jNV4H64VBkKiYHm3/aMI9WsyEcQ7hB2aFwFy
H+I5PUdkbV5aQ+8GNSlwKOPOMqKucbx+lxMIHku5OslwRoXqSBFKFrh9atgLTrqm0Kzhu5ThJnO1
/GOgJimx5f1qZ/qphX1de/O0YRe7A6X909D4c/W0fu1vNFJYRXdtpl8NhuyzburvKlkszMKwkzc8
bMvAIx2FE4VpUuPh80C/9u3gPFxKYijS0MBwi4rYYyNsirKVVZe9jEBbDYt52PT2MvZdtgcHKwGS
LrQIqhCfV/KIb1Llch3vjArMs4miulg1btBkNiZPevGLUFQPmGmBth/j5pqN+LFrPe0QgC6LARdY
Lu2qyioWCBnsJvNKk7a+tlQge4+2exB8eVoNDp0vk75TqdKnyoBl2OahA4ShEwyjWfQYNAoMTlIn
e6Bpqog2SGlDRBtL45HzWen02S8whQACz8Vq4dyIWWEDJOsuKUcmCY3PDoqa+5AnIPBQ3rZDdskP
ZggsAvB8PSS6OUuv7L6CvfrSoRcPyYtkrK9I/y47n2Dhmsa0aBUpq5WFT6rHGdnTpGQJSa5mjPVj
3SidhzZCTapU9jwtbM72pAW0aiegrl2zXdtlyX5x279vqvuC0dyXoO5YkwNrWXIfBe6ram+zL4vV
S2Sruc9VFuFBXdLx2JkR3azr3CdF30VzuSrr1twm8Zx3aTUf54Ef+YzYu870cc6CuZtzLb3Bo4cV
cxP2T9UG6Q4uRRzHTU+bYrMp7kRH1nKcgo9h+uOrZTk5Db92bprlw3vHH5Y64j8JAvhKQOlw9WJC
yiHjROFqWC37pe31oUmT50kDiEpM/DS2/Ksbgxdla9S/9ngbmg1rpF3ZS1NLe0TcUoigVNocBqzk
i6Zvlmdos0ibH1oN631wO+kYV6h5lmI5QOw/77ROMtTsgt1a0aPa9leuw1O23nJ1ItaVPOp/TVBl
vbRV1OZTlwaoJW4fFF6+EjfLlvdj2p68nkHFNvjNhpmf8Tt90PWbWqt134X9A5b16HlkYK2o6rZc
L+tz2jO9zySbPvqoxZacVYjQFm19CAB754m8rZoLUqcsR7zguGFfwu/n9oG/fUwZXlhjRllGjdV4
8fAX2IFRPRvd6j0eoB2tZXvgC0bgYLn6SMn9hD28YOKZr2175zuBK4tXaLSJ6FvP1DGpLL50wI9X
wIxmvwUcGbc4Fzcw2i9xX5NvmLnnq4vpetKdFj/Zgn2dZmo+Q6NUbqad3sd2PrN2XHLT10hv4YgD
77Gfw+/ozVlSaSLAqiZ4mxpnDkIF5G4DvnGyLpz2bOxvfKyuf2/xan5u8Sj3o0RH6V8Q0L8EEr72
Gv/7Z9zvHxDC/yel9w9/6vC7v8km/ifoQG7I338DIfYTeL9/++x+/dvx97j9rnosO5//gCji3/87
ogi6D9hgiBixEHm9N/Lu3zHFMP0bizKG5p84S2gCc+l/YIpJ+reIwWwK0U7CAvaXMOTfMUVAkTSO
WIb4JZB3YZb9K0RgnNxkof9HgwRujsVphv8goE3ksdD0nyRkywwpANYg+RfiBZJtSXAxCK2yuxCh
eUkO1Gj6uM14qAhPKwYrz7jNtNBDtfS5hbRA7mXAk61Mptl/VtaHbxOUELIU69alRa/HUe6WzQNS
tw6Lzm7JLCjGFKWW2QnthX4uIwdAqFywjW2YvQG43KfB0omSI5DmDwgzr/CvUrHsZqdUndOWqG8E
UySGDQqlQtGlkqGlGlDsmUUWp2oD5vUbJ0nzPlZ1ex35zMM8VFn64n0NjkmkmJHzflv0SSioonYi
ZR7/oIrCY9i4CIaXjgfnbEXa5Z3lOoMaIprGS+Z8THKXKbqr2DxemkTxl0Dz8K5ZkSpDgQNgXewy
d+9nIe+bNUYAyIxeV30jIrTO6bwNB9sG0Q6/fftdVNV4UbonoL0oCAP0oPtU5MG2wszWDyD7chJL
6FSIt3+mGsfIRSX43MuhJTwouW44uo28GrPd4CYeH7dkCsS1HVto3Nc0QL3SEGCcFHSsgS4a3vzw
ScBc7i3jD1DnpDVGAp8iltap6o7Iif4gCD33+cw697NvA/aTJGZbC9e1GP5SUIBAWBp2rITMeB5n
GpCAU6J+YyROx9yzbmGlC9r2/hadfj9FU0DyKHML2rhrgaeszqx3iO8LoyttjfgRjbNY8+bGQ0Uj
CU6tvDGo4arGo6YsHQt8+BCQbG03Q9urk+bNKYlLD++FeZNMV19dTT2KvUXPYALXenvX2YgrQFdG
kx1bk79+dBDg/G67FlGMQZA+bq7R2IwNowiSoYot++q2VF0onSOVY78YGUwYNLzIdV2r3IwNIAEj
ZQ14Ayjci9sS/GoDm6M8Xrk8Kczr8mTWAXiQ1P6e0a39apYA4C6lPUI3XBVeN4CXUT6nVLxAt1lB
etJNIE2B/gK2QJxfrDHKzj7aUUtVjTdM6jvbEZz/ltkEj6vxP6YKBvViWyYQlEmn17DYsql+ITyK
t3xu1uxnIx15z3ACYIqf5fIU9SJ8nJcgwUAgI1fjfsZLt4ciZz106DM0pWbAVsqYCwrYQsh4Oy8V
Db+lA6M2b91kXzMUTbliTNZ1Kce1Y1Ai6RqgOllZL8s0wDAE5pFUN858WeJixVz3K4CEqy04qLLH
tuXde7Oo6CcXevwNLHxAZ7zR+ODWFkib9991GvrvKoja59jX8XoAAdotwJJr4w+9a7Mgj0KRPQuH
YPBcsHBKAOkvlQY3uVIUyaps5IXsAuuwWoruydMVxKGvtqBgluZjPJt3MtntJ1jFFqBT0Iwtfs8A
TGdvOlICinIHRP1jY7dBkpztZFRUZkOX/PKmTT4sr0y9i1YwiXiePUtxNY+8XJQWScFru76NMsTK
LbO23kqoPddkn60z4NCJhN2XWnWIaRJrUF4HS+B2SzJjdbeiy6adGSGmuqSCh9/GGWNo3k23IV5g
UfqmY7o0ORVtlZbQvVE4uYGRYjq9Lddya/1P3BNonk8BUEGYFkTmQhCyOBZ4CUBxRlSqekewpr5P
PTaxnKcNWggtBtctN35p+qvE8JEWfIlBgpNFQoUgt8Dqe12N3c+MZzKCeM7PTwsfgB22WO2fIzZA
cba0cVAk2wZPPtS6uA02u0XDjVTf0hLWprE9M3waS8EMmvSKuulB/3bBBowtM7JHzRRAJJzpFSVH
h1USMRwLBc+scUZ9g8ZRsUONbM7k2MVV9kJUO6JCnBqV7kkWBPd4sDRHYKQFJDY0gsqSTVMzFiHs
HX+A0URIgsMiIl82syl1RmwxIW+Ay/HHa1xYvGBksOEO4UU2u1Q8RXmaNyEnuxmX9g/uGUj10APC
zFvGLNuTmUT3AW23577Hd1pyUs+siBhdvuauU+90Tvr52PeCXUQSIkiga6YZUU+Nf3DE0uGSdgzR
xBjia2wDbjeSWkN4CC1dW4q5rn/8XxPJf0He/aPe/XavQ/6ZIa0i4FhQ/pO2OOk8RGFZg33XyulR
k6o+4d5mJWG22kWyS0vATd1llYBg//WZ8f9vIPwfRyz/t2JgEMuf4zz9wxiIf+HvY2AMaS745CCL
cRTHCK8Gl/p3PVgU/+1m+ACySRkiodCC8x9jYErxf0XQ8uKJS8H+ppCX/e8xEKwzhFuQKeDVCjG5
Uf6vjIGQgv/T8wJ2l8IOnnLMnCne6n+eA6HZgchJRGkZCig6ds0IyDJcBnZQ84b7HthaDujmAHQ5
LMeZZCfkwDw4PzRxXotNXQbVsEOXdD8GKEnykG91sfWpLeSKWLgNl3BkorGM8BeBoDN46qp5PWrc
Uy8gPdlOeUDqtRvPQ6sxYiIAMZ8CXMILZpKbSoyUKaCgc9aNB6q35U1kxEF5FeSxoFOJP0UL7hta
WiRKF1zJbQ+iBFKpzIJf0wyHds1S/YSSVH+EfvLDJAichvitdPOE16+aHjq1gXrwUPqLOriG0QYV
JcFxDRynhhzSAkg05kBjg0Ns9dNFO8x2hnP06OEbyquh8hfdrL/QDp7teta9VmrhhVb+Lgq66RG3
8oA9uII0KBz7c1d18SlGi8e+m+L2SLnuL3hGqnJErQ2ufkWOrZjAFPcNgdCzni9LO8dIEGJ1vc/A
9Rx6LyK0NscbwfUDgsSNg/wWZthTg81vr2ro6aUhRuRtPSN8mmfAEuJNF4CSr0nazH/snB2hTN6e
u8qdE2qHotYhiPssvMoBVVRLH10hlF/PUot2gmxsqHeVZ3aH2/j3YCKNnDvmkPXZI7qXoxP9bWiT
X7xtRqCESKDm40jPmxHmKDb+mZLtoZsqV8RJG+1dRzDabi0QcaATO7KkN8wBAjpw6THEa+PjErv2
joDeRmgLcP2lwWMQK47MwR5c6SRZAfqRH5ttPsUgZHJBACi6vvEwUUBIVEHIiNG2uTRj+IPXAzpq
SVP2Ca7OEKki+AZ1uZGavK6VtI+YZccfYaC2Ag2N6lj7QVyqIUXRBkZbDxDNAWWgnzJMymQGTxiS
a6XCMlFD2baYGBZ8j6mZrr6uiiGkV8jAzlWn3ykoYzxs+C6gKki2I7yUb8vUoUUK8aiDrkkOXB2T
anJ00H4+6K6BlHgMt6OI9bALUtU9QJ57KwqbIb7PM0hK8Xom0ze7qDQDd9QHZ9X44dIsZHxzmJPV
BooOr9ahtYjix6d/GbF/3fR1xbANwG5niOzBldaTCQtQBtkRm272AIA3/ikJ6nIISEPosedpBw26
2SeBh0CtHlZb9BGx1zBY4vOUDglgp3Fguz7EXqehRtfW39hMtMsh0h1VNLFr7qSI6ZOyk8cWWdNf
vl3vuba7WYIubOK+7BSuUZMhuyhAOnMZCexVim76LelDjAF9NX63ppKP2pghz6J0PfvWNAVSTMbC
xzNyYLb51qU8uwC7qV0e8Vxf2RTNL1tVRaiXID2Kqyf5PRLTVEyAu6yczyrjMYiNVRxAUMB0jEJt
lbtZpecZWlAMOIhEVN4faqDVuQoqW9RO2nPMPhkd2MW5AZB902K2Amd+N46zxePEMr5nCaa9OUR+
N6cbeWqiCVJNJ3EIAQMvar+I3djQN1qvH9tUY1GMsgNvtThVju3aDkJ+mvFnCAddIQUjBQLIuxLE
ENuvqLQ8dBLSj2Yictdmgp8HcYs9plWY3vdGkOcIFRBFLVPx2Jv6nkU4F9IA+s2GkntZ8z8G8KQ2
UJa7pv2RjjS+29ySQ1FI7wLm0+PE6tvPdRCOg62MC6Lx0GINT/PEzfOD0xSjYtrZY700XeEGfS+B
fJecT8N9naXqDd2+WUGQUJEvwjLwXwYMG2dmB5emOcTxhA0oStkhwFVjIDRNoAvUdsYsnrAqr1Wy
S2QMcNhBbNfkXd/bPBmdAt06fU7YnSOvd20dPmiuP9Z1PtXb9triiqhGdl5MsAPZUITc7ZKZ4fZa
C8mRXGFhkVjqrHB0ytFP+UUBFKwC/lDeXEU14mdH92rJHivenFMk8AwOIWpQWGBgHSB9IWOeoqmx
NGGFndilEF/OH7ohD9a9+6R+Af9XKLlChDzan2DQFRBiAuUl/oILV48VEqxDD8KOoHET51KxztiL
pAEb8eVkdrcCN8/T2kJhUw9N/cTqOHjgfR9fMbJCBqjALBdxNNtyXVA+zZdenZC5z19Nlf3q9aLB
oKVvwiz+kKJBGr8sJMt55yN4WdLBXVzoAH876PltUP/BE5YdeSrbqEwH09xDfKwhXwT9KGyyQuRj
F/IOXasoZTuKBwhPE2iQ8JtPC7herGyXtbN3UY09MQ8nXx2VbZu7aFhVi5Uo1Yd6BVfI/JA9mz6r
Pgltw280a3BNDZLZQzLqBkQtKJe7JQ7bMweoerfBG/fdyvi42DX+quFNKapJ0q+xRXLiBJr4EHOP
cSFeCNtNNkqPhEL2DerK85MZyXocOjW8QpTL71cWmIdpkjgtaiDheA1pd0DuL2oT3e2fASz63Y9e
5w2np3HmYPJsVtPHViJJnEwAamkK1jBz5xqu448expOyr6CNXsH151RBEjGOBklvAbQZlmw/t21h
CifTiBC6etZXiGuAsODU3/dx9tILSG5FZr9EV9l86+op13DQAOPfwlOVmQFBdXzcESTdfTlX8zs8
WD96oDY5viIY06E4DE5Do5BrPqbZc61ndn9rBinWaaNHFzT3Iqs/tIjsaTHbR5fqo1rsiBdiDvJx
xFLn1zZ49XIJTrbl6jijfnffpUsPI2+PyFXcy/jS6+GOeBc3SJ/YBHYEn6FFIgAXb3CbGTaSPahu
JE8HdbUznd2uFTC9g9+QoglK/kHyTue2rYICx4SneQKUvJCAS2QKZhlSfGxG0Aq0AJk03CkVWz8b
J/qPjjeQ+phsOQuLpa7MJpi2YMGpShlP1XHmqdpFcfbUWlbvx0m3hzmdalD5fDtFqmsOc+j1Nx1G
rkgtLi7ndbZr3CjKaTD6wEdVNsEZ0914N1XYlSHumEufpHfErhKrKiCrIC7hgXsZev0D6rcXhRaC
JmB7a92jmgBU1lQ8VqFoTvgSgUkliAMOQx3s6mB93bY2ff9LN74264GrXv7MoLUBjjB356mr3WM/
ZQ907UFkt2nWFrqxXxKNrPfbFBIP7XGoduhP6gp0hD7a0bXvjCTpW6z78IEaqJFQgbZgaA4saJKq
f1X4FK+8imzZpACzesfgpXMrdIKRB2+YcofJsialdWL51cLRcxkyso83UO8WSuVcCv2zipfcAgPK
U272rPX3I49KviBRhfoiaugRRMmUp8Y8s2U7Je36va+qE0XXHAaBZDfRrGi65BzJ7HuzLO8+NfCy
BfdAQzDXLRVUTC7Gm9nVebYmKOKZ+WGt0XaqRf1N0nS3bgi9dcP85OcNI5uezmnDz+EaQCDjReld
4w7bNj9nhu5a5EVNnsCz9TOYWTnVwaXtVgB9cT3+0CT7MffiVN8MGC7r31ym/2RrtBcQzuUd3tbO
Z/exkaDuJ3LXOWjxM3sGHbmr+2q3df2LJGj1RLkV5BNh3ovoufKV/u28oiWcf8t5mOf0alqIJLea
ystE6v5+QhM6TnjEKTQCPiypMC9VDPMRq6c7UiHIFXqFB1YFH2TC/bvoCAxOAkykx1mHX6lBgWSV
vMPogtiJEKfYxpE055r+3Ib9QW9DAPJwfVQQ9QMtOzHT7Lqg4xjhp6ps5arugFXER/jEwkeEJMoj
FHnt47LVkGr6e+LTawxnxUfoXf/Dpsk9CMQml36JDgKiRzxHnT+oMK6etfbBp1+h49xayXcymH/H
NRl2QG8FVKTVXIbjDK+BYP4BAsd1xyU6vviWxg9g/+7jDHCQshrQmQw/WaPMHgNU/VtCOZ/juJFf
HfQqS+dwfjG8Os69B53s3nho9h4KRdrVh7CDYhNiG1wKEFS0IVLwEAV1D7XWL9qFBqr+0d53G27S
OGjaHNAtKLuU/q7DHvOW63kRmHTvB5Dz8NxnIL/NkF7SSMTnput/ixn6km1dozseV29TBLBeJD0k
UdOXlKs961nFuxA+50MTtneRldUnl5lBWq+fUM/RJyP6uMMs3aHkRn8Cb5ouqRubvcu2XRs3fofR
Mypcq+qHZWJ7zzR4BVx7+riOyXFK+zvKNv+yruMTzYzKWTc89enNrVh/Z8reAbdaclE1X2ndopqx
anae8COB6xXXGzptgrk5wwWQ3GUO8wKOo+ZSx4CPssnSMtABzReprmLC5MaHbjskLsTxJ7P4XSAS
oNRJTz+7IbYf0N6UsW3LLSZotuUMy7vd9fDt1Cb9pmGUKbABHRMfH1GsXXTzyI8j7p+DSvFSw8nh
cmRWXxJfvcELQ85Ltj5Fqvmiieh2qONuD9SZT9dDUQK1d5a2n9bDbWqWmL0itz3YpynG6MngKBI8
hjOlx8XW6OUKJI3mQ6seCc5JIQLEF9j4GJJPpwkUE9Bo+IQem8icF00eU6D0n3ZxQHIjqU5Z4jHN
Erx/VZVCsLC59tj4NH6FLRrSjHREB11sLyNs6eA9BlsMJgwKsGA/52Y8xWzQlygI5H2yqWXHWTsD
Op6zi4/GF95io4EEluc9Mz8yL/gxcxk9AsJW2HJg3hpkiLOVb48x0W9gqhH0kBgwQAzhFa06x83w
DVAgLJzEjUcAG0DBEQ00XDZIMXcJZvwOcu1kAFC5YHEGcYtu1EBjWNbJW5aG6o1N4YTxKyInO6np
PVGsuxIGDdQ4AayzTNsnC0WWKQG+wpzqamTRNgrLqQqhBep0VD82BunzQ9j0pa8xcti0c9ce1/xv
vmoJzRYwYBo061Wn9G1gnTnGkdJfog/H15bQaDdsTfd7BPh8dsna7dmStOUaCV3oWINCgGWnjKNY
4MyJ231Pu/b7oCT/MLGeP8FdAtds0t8ymkHoZAr0Tc+GPZBXwCkZEJNaw9zl6uAm49IzeHvcOr2v
zTnI1n4vVNzuIIHZvtrakMNA6FKkEDEi+ksR84yvxpWT4gbevaYugpUuDmn8A8mDzrEXiMMBjEPp
/+RlHz/bGPW65UgWfbRuwSo1LwjYJutYIH5sfozdYB6xiGfXvgs89OiWXRYCNh7EhCraDMazFRXZ
UKtPGEB6KCRJbapdt0EwqRhtTllDgleXhc2dUJEoNWHtnYyQ46Uhhc+EnM5SVPCDj0S774PD12AX
vp6SoA9Oa5C+NGo4GJr9SS1klNA0IJd78ThZuyXxl7mLHqIRCuvUwU4AWRO0gXmwWmzNoAm+EjaY
AyaYLu9CCP3YGMrnud6+x4G+q/w83AfKZLu4b/FgVjcxRW/DX4NAEG0eStz+qJfVI1qXRIftfpnU
y6KWL9OSrYBWsXpRUwyd0IqE4JJX4iMkEZySRAA9iLBa31Z6/Oo1gdWq61eggxPAl0V4dr/Ctl1G
bfURNRl0dg1zUYn95o4De4a8nMRwCkDs9CFmNR0rah0OKIOPLWk+Em1QIyiCL5Gu8GPh07lg3Kzz
NYGU3Rr1AgXvB/HjlQsRAjJyuhxcBMc7Xc+kQxpWMDGULM0uTLBSVdt51Rk7OiaD96wloI6SJYSe
Bi7z5TR4VfHcQ66XC4lcmxAC6XJZAVxYF2RH2s/qPZ5DBE2DLMQnFm6XEc/2RQDTf2irBFpIWcfv
mQoexsEkFU45gXMZhRW3YzoAGFl1zY6kRky5EdHVB5vDQ7it9ylrU6x0Xf3U94M+B1sMU2oFx0wN
8QwER1yC7vP2N/AZlHmEy3ZG5kF0FDNBrw3xFypjcgiGKHxYNbvPQNyg4XQfx+2S98siXk3X/4Gm
E1GKIKCaQvp2Q+xBnR7GLZI7OGVIDjjRY1SbyGkMsff+hUvnFMaWIiJVVyyTMLuVh9gjkScAEU1z
aDvUoxeNRe5CzPlejBSpBLBdyBh/54Bh3G4Vcql53OAtMMsLaLjqChtrtJ9hTT9tEVhHgzXkg8pp
p2y8HceuHlE2uGKKStJHGoRogGHq1aQT1iXTAD0xPjvRVGHuXFh8J+gQX6JE4PZcpuBs7brcNapZ
H/oVcyR20AjWBqtLGVWAPZPxCN2xRUpSz/apYPiCtfsMIvZLrMDk6gYDLmSEOhg+4NMgR8MhMGaL
DiDtDgFLTGKiB+lm1JS1CjrnpP6xRCkU768kbEqxnSvfl1A0JBOu4i18Spb+tAzTtu9beHu7gfND
HEJLNYXDE2/Qz2TtAzoo7oLNPHiOQXgNYIQa4HxOgLTwgUQ4tsy8o3r+hkcaq2OdPmlQR7ngwXfs
ZWfuMYNDlO2HNdgHYQ8tBDCMcuLkpdMMrfTLUP0SFN8EFAr7rk54DsthlHsc4e9hwM/WJc9BCsF3
l7R/6hqTH+D27puuwYImAXID6AYX0RAvXwjAEHvh2+dOVKCqkLPxTkcoQW0EQUEh1cQQQ1CVNKw/
DOAUb5JnkkEgqM89kZeA4JPkiv8Zon4PbKSAYg3tZzOFILyeLozGI9Z6WJ2pDSn4Y6bP8TiCyk6v
GfwxiDSYSTHM68u6hXa3Vuv3ZExrZCJ2f8Jx2vcqEIfGwEqr1iivic8OHkj0sZHdcFnA5u6cqc8r
W+e7ddL+CJE0DpW56i4tZx+MevErAsDpxfYWAtZ+rahqbjdoHF5gZfjCah7mCq6GfGrRtCTXJtwP
6Vr0mH87yGSgwhwFzOGYp5valDFJu/U6zUE7AreV5ifWYAKBIrPNQ9BsOHPGNYwnOEKDfo9+hHXO
FShoAHHtHA43r2+tv2jWwffZa5CxCK+Y46hYQXpS/PCN3bBoSGeLxjXbQcQpwVbgRSqKbVDmF7U8
ue9lRdqzyBDbijCHJvsIHaS5Oc7I/ufCR56VQzQ2X1Z2yzmaKo/clRBWvgVBHzsD+/+3NV0h6duW
H7aSNTQS/D0A0XyTnMr6nJEY8js0NkC2f8WZAawNFPk1wGry0rGhQi5JHBxgGwvwslp+X1WTfvFd
W182KFQslPQpOOhaBKUTbgZMnIC46VoZ7ud+ZY88xJqHBIr6Ak+vxG0o6Qm5CWVaS3jVSJM8zRu5
oNPlh6lTBURlO0NuB9NPzA4r+2UTvEsLHFA2WH/PjdTvMyDlBzYlIicEw3g8d2xvLArk6NoNB75G
YHw2uGq2m0eJ1yZDN1wFIeHkf3iePtnQydNm4BSoVl89c2SppCC38pTgHCLd1r4JJLLkwoAUFiDI
IkxgOF69hMp72rUMHqk2UWfXYtMLIdudB+lKKMTWXSiUPCwRKA6lgXBLKzIUZQ7P4UCBudVP4RLw
n85Ny+e0EuiHNlyAIPlTl6+bhHGhwysXebshf7ET85Oe10cQ3Dg34tuw0tL7Fbkmu6T3eIt9j/7j
lkSHuNnq01TJN+w3b3hIo2IMVd7Hwcct2oRl/4u681iyG0m27RehLRABOT3AUXlSCzKTExiZTEIj
oNXX3wX2tdssdj+W9fCNakCrPApAuG/fe3n8PHjrua38hyqZ1A9Er4afzDZFKBruoKTKi/2ALZ+H
jd0+e8vsnpUQ34nEIxnBr8l3rFU8acA4+yISBB/c+jab7Q9r5ThujEHdgWDeWQ5BpakWCNDRKqgK
WIwRDIT3v6C6k+6byd9EiiVLmnJk10ksDc6QMK3JTfs0tDrUTkdCzVqdYEg1jqj+HHURYyKfppnn
vQLrWY77ek4s8oJudjSmNS13jfac+76chqCMyuHgjHH8hgr+E4yTkzRznVff0A7PGEE0Aj8xp3hp
vIp2iThQOM+XHTaK6jFvhuKViVsVrhS0tMgVvvf0x4rxhVndu1lre68gWLzhevmCND8ca11997i6
OdeJvhi7tXHOhUwZnOSVbk6Rpo/u18Y/0vo/+ybqv9VS++jU+875V+DGj4IScEzhRdVNpuzlgvo+
71vRtU+Wk0t2aIq33o0Ba7fK2vVN8SiE2DgLq7WbDGTJiV3FO8zzOjCgYO28aL0rs7o61l3XsZHM
SfdrPJ47B76FLvN3fEgvzlxdTcm6K4z8FCu2hw9t1V43ZfvJYyZEZixSVMtZc8AtxES2Me5dC2QH
94JV3sm5HOmy05NddssuttSyW1tv+kJB/tCnY3GbNuX6yWXRKAJ5xjruydaPVZn7FCO5tSnn2d4i
7HPNkDF5bJYMLwfDqQch1XANV9UN9ehveU+2Tc+xGRSpMBB71rp47igU4bRFGHJK3zh7vZ899UTE
Dlx2Q8+qn2UOcFMuh5JMTchjj/2Qk5NfYqdhhbQh3zksJQmHifO9ZYyJQQX1w9cE/Zr0SXmGc1El
vhOnza/rBE7EVCfUs0X3KV438U3WIVnjD2n2Z7NYOevLtH5pE++mF53CmU79QsRT1gbx33anbPl1
YC/Avp29sCSjditjod8rG1D6gNk8AJBEjtelFeyBR5y5Fqtbz0ntC/CTNqwFGIEyfox441dx5wdL
vo2wug7DEoz/ju6ysi4+1AHO6CxAo/ncNxU3q3A5vlR/o2fDumqcZjrVegmNua+e6Qq7wJrks9GT
QaltfV+Znd57KdOB2O/sgHiL2g0Lw6pkLbhUsfsoFSHtlsOeDqkCMygjWiRjfsdDl+J+gS/z4OgI
dzO7/o4tki9bbr8bA1nRir/GTDPr8eY3/o2s2mZFRpcW0+FmCw4xwXWW6VM/DB/9RJJHV7ToXUFL
oPWrF8MUpe8Qe1mo7j5ZZ1bAJFd+NO37LtoTbkzCEsU40I18bpIyqPrs0jSOn1LET+tDvGZwspxC
71dJZjYTUNvz6brpTBYxmTxOo3azyJfxWRKlC12HqyzvGUfgT+TgVB0O7ILebHjwRydn1Zu+Tsfm
Nm6c9CZ1bcE8tASKRXrSOExTyQjYtV5GZiWneDKyu6jBbgbSBeXWyFtE0Up5V/2MpOzTHs3p8lYy
sYi5Qc98Q6SJLDNwvQphl/WxqSx9lqgx+bOY0ZymLrKOZpIN35esp5ue4/4x91c4VMVITjPTM7ew
jPq9XWmXPXVmNhMAcL/Y6IEXkyg+ioZz6CoLIo11QddW2LQoPjzdWk+eTjLm1nN9snrt4KWrqouX
DNltk5o9BRJ+1dUQWVAulbkTDdIv1Jn4VJfmPfbZ9jIsHFeJjWXUJ0/Njwj8JXQrqyfvmFvsXnXe
pu1JB3Us3jnuwLzCYdxYVrI8W5o0rWvK+BK57ZW5VgZmRfTJ3Hvr6p7I9IwVE2ftHsrOsG9SHrL5
YqibiSRxuSanOGm/d9LlG1mCfm6OWV88ug5WrvGCvhYkcnlWDbd4yrTXdOowql9NfqANGeJnxQ2Q
GxnU5mtRIyd7zZNhI6KkC9en0dGfIf72zorwnh0mibjayGOPy9MZzdt+9iDejKMOpD995na9mkT/
RES/2S21POedg5427sUyhiWp9oz7qGryfS2hbk9iu/2ZBWPZq/p8OeSlQkjgGOtqHtIrAZSmlOfa
h2lkgEHLyN9yp2Qes8GYoCp8EtLD9r4hxV2tvPOkBxswpbSVI6lydaYbQF4wrhLTdRk/l0j7zAej
4mhSZ55XbZl3koQu10ypU2IOc74bCCDui0KLAJ30HpqJd8zzYr5N+mgvp3o4sQ6y36Eq8R0K8bJO
xjHRc3VPII8FioPH48rykjs5NOyF9YmW4bphqUU/iJMTIUXlqIo35iS/uG6KJUSb+Zl7w8qvQcw0
92Qz2aCcZtG5bwYKf81hJrru2+zYxpFH492KcTg0mIlybFsvvcfcpE6T4pXTAo9ApTGHZ5F/TNr8
DSRZyU2ZsMNR1CtmQfHhVdZyl7rkLNK5G2ge0yW0oPajWLvO57UcuIELxnpI6bRcR2Khuxb0Qmao
N0WHwlK7ow+DVG5bQTwECDXV4dC4jNUXGeQ8Fve2Nk+R24SWQyDH9NLvtC37ttFHF9/wKU67K7N2
m72XzyuJ7gEDfBdlEqUyyskdJ92rv5hnlZJKHqcw0/iNV6/2se7ROrY5ZMftuZh9LI1/SIDuTKOT
8KhN12AV6sadKiQo6iHQdk/4TwjAwzRYKanHG8exDrZA2Nfy0TUN86GjqaO58R7zwns1rHwiqogo
izORsBrTmsymYm1T/55fwrir6RPelNnRaPdR6x0Hq8JrY3WpvMUyybtAwKrFELp4veofiq6OCSLM
q9M4ii4wlsXC6c0+TztB+J/9lDg0FloG4ZcuZoYvTY61TC3DPim8+JoY3ZM/AcQaIpvsnAOPEHGG
1ixKDYqYBPmiuMR0+BpSosicezyzd27aPK5G+qk2xuPcxUevde5Ty32UabmBghIA9CPEpdj0n2LZ
MK0iY7A3M79kwJYQOrMaHE6C34vMWiJ+wGQjvmYabvvZ1ElJwDtRfmArL3shsQSRYkwSdo8xhx58
zO+I3mujyE8JvGGx+6CBX0VLdyjrAUHG5NQjhxjv2abKRnQqUDZRJ7ZAg3YbneBtln5y9EBYmiGe
2tV59vFdhzrpknM7xuJlTucsC2nzbT/kxbmdbY092i7I6VfCIWbWr/qBfGJ8RSGJ6cxXm4YleC6N
RMU+EjfCqBd5OxCNoe4LeaYnLcKxscq9u+maJhaDQC8URIY13tqdW8DuAhCoCRViwqmJ44lQ+9EW
vNwesYrspiXjs5vE7U2Cz3FPsnJBR8o+44rb9qj2nzGO0RGoYT3rtowfFtasVh5Dh8yt9ti6PkTX
hOsk051leMtedQ0a/6rgXvtjvfecDCxKV4tjadoEM5N7wWOI/MlDxgUXJFF7VRf6Vszyzs31y6Z/
HjrX1GeLJE2gJlEcALFGO3/oGXHp1H9ZZjaqubNx2+aSh4KDwjAwyGN+3j5iMGOaue5n1PadLuKD
Fa93HtjL1dkmwwCtQm2qR9NYyKxrF6tN8ZxXuBWErZ+0Ea0MiV1/7xrEOaRqkLjo2FvOcAQz8DjG
bd31ydFI/MGA1kksNtHLtxL7dVi75Gcbm0y1SlDWsr65Hl3q1apZ833c4T6c3EU/Uk86F3cQA6dP
ZVybJXd3IX/eUmN8qK1GHnSVxcHgz0/gMplrieaYevO8dyNBKCUZsfQRzKA6ixmBj/ih9UAGpjAH
HPMqrcNiVfKwpPMVdUlzqWttHNtc99d8IwBSVFG+xUBvAnetvesqpeJr6umVjOx0yixRB0bUQYuL
JwyCa7seGdZ5t2nXfIzMEsAzxNN+nNP03hg7ubN5PkM0E/vOj97LaqCmS+KwwrV1MkZ/OgBjpnK1
qMrQZ6JrX0xfmLt2J9ycHJ9ET0JDjT6ZbRGfptVBml+n+H5Ajw0zULlhPjBuibQlbrHRkcKTrGWB
qGle8VovqUrJ4yWLcZcvHqE6RKTofjVgjtoZz4dWtuLguGP+TKU/BwvSMeQC5d+3Sdo+NJpo5FJT
CtF9WN/iVkwXTPjrjV/PJJOcoUj3vhfZZ8upKY38oTiSRAYEQvjhQRW2vNAOTTc1/kwwa9hbwJQt
bh96DrAFhK/loezy/vtU2jXtcxZ5z/Yo7ykjiQlWPQgZCsaeGamIGY28Lkk7gyLA11aExVKI0GAm
zLSCEWho8O7DsSUhuShIFbqWSfOljrzFCArswD/k2Ng81HBy7RJ/wdFa2xYe3gQ87qVTnaY+qrsb
CMVjeuiXzfRBejn2yK6q+D6Xen2oZYUqQ9SNYkyD+GO1ZpPU3a4CHMdpJlMKmXQthbc9onGttuyN
U7V74H5uQ1ID77VNUt5ek3HXlpjz4YdQtYFsYm+rE4ckI+9lBXnIpV9Jh9V/GByzC7G8iovVMh7b
W2k1KigHk+nTTWIHMZD3Qj+fL5GSz7X22ekyUQ4tY349WX79YI5yOGTF8FU31p1l0OFkFkPiEuTa
FclQ4zRHTKlLLan1YlSzxOIvO2iIvV7NG7NPz7GhAb545r3K5uU0ar1XFfBbD+ndHV8TatrIH/bK
nw9dP14Ev06aNV+1H3/OyKuIJOlChIDryPHP81DshUTWozbc19lM+MYcjfwwcDp2O0xX8VUTD2BY
ZjulyVmMy9rFTZj1iXWkCvL2xHrUJc5sXhPv7jYzGr/IbjnUWkDPXCf3YCYwKpyYEggmgbga59h+
bBLmnzudROZXMPzgvMY6Gj+t5EC21Gv2tSeRFSZL7zthq6Ji3yoxBD3FbYJjpI2uzaLuXynAHkjt
DyjAc+ydjLgbj+yOJCJe6oyTbcg+nDIFtuHUj1pZMy3wcpdI8aFtySDaOBMNvxaZPnCR3jb1GHRT
i4nPujZ0+xRV9jePWRc1hUXf2PrKOiReZBzmzKhfHMloeId7+xb6PmiAhnAwcXHoU6W9B1jBoY29
npzX4M2F97VoXQYDCrZK0K6V+tqSd3ubeyq7JE5JDLVyJOJuFGc1VfZeymq+15V5N0ztMIU+AuS1
M6E872ju47dk3a7SQjufyO2tu3yuinOSgzquU0U9zJnoTv1dmQj5UuYFhX2S4vVphuTisiSP4YIZ
HZRhyDdU1kfBLOjKLbg9aBCM7+VgG3ieU+2/lDWXSa4X8mG1l51muyLSV6r1FZg0sgcj4w8MFPrG
KpfsOcUty1jCMM6VbPg+avPraMv32qf69dIqu5NR9TYUg3VDu7J8FlJGJ8zT7cOC9+fIfixm+/QI
56FumjshauseX728ECTKrju+3Dueyswu2gIsVc4vmbfVdHazPP/Wtz5eYIwZ/kwkyBoQ+dTSDteV
XJPb0ljKfVy24eLE2b5tTf+ke198zmb3Gwza/jJOyM1OgZ975gu/zezFD+3Zeij7OJ/Y012oL3HV
zaFLjOiJ+zVgSkrYPHXEGV/0dV5OP1gxfV77uL8sYowwlYwZiKihbse9bc0fU4UBLC2WjcW5HHQ0
tKE9LN8Nd+zBLdX6AZwsZv68Z7f7ahYP7rggLQrPPEQazAtt2uI8ZZo/POE5CAqhWc3k5sADOvtL
b+X5EtZdFna9N3x3ecA1uxX/Ma00txcaPyJVt5r1MXWlvK3Bk+1NlX3TscEcYbK8KyfpPjoIJf0J
Aao8aGNwn+jA5N50YsgVUHuYqddfspER42Sk3DaeJ8K6XF60QfbPRx4KfNs+S8PTt+hB1gWNjcfx
du8v2frmJvgxGR77HUpL9QTpi6OgK5zl1E1gUwffvy63KYc3V9VLWTjWbo2JC6wjP2qV4zxx3Zjn
dzp+aAcE+ihLErYaDXithDyoXuDEGhaMIyrq07BSxnqYOoHfvkwK99RrG/llVl0F1WssT2ocbebp
RMEmd3Xf6D2YGPfOmYUIl76R2KzqyBpOjrCji5k31tHtjfyc0siifpjReSnJkg4b06Pxs4tNwOZW
anJcXlKXQb7htioPzphA1rHzPN857Im8j9YeRi1wkCN3xMoEao2eJYy498rzodlA7zxRLhSndfWy
YCKXfRQUXF+xAGKElEi9LqI6dR/47wa71N6GGgYy0Pw8Rg6L5KSPmXdCZeS5LeIvaCYURk4rnkqG
90FsxH7QOU73WHT+la+UhkEx37Bq5T1d6yFgGJldMwz1gYlPap9hloAwW9HvKGBeJy8d4RjhigjG
OX+3i+lTndIHE8vGJdcM545s7qmHpEzW2jYPulueATsun+bEuMOAjR7t+i9DCp4103DDiQjCbbTj
IBWbd7jxz05V3VaF9cRugQ47UwddMi87wr0DofDRJjmn4mNVRWI/NvpRckw/TF3eHUvDImaciOyk
DEcD58UJFebkXl5kVT/gNrCDDAUR0+w2gV1QYwWEmF2s8lsmCPupKazn5ufFUVX2o8K0QSYOPr5O
qNSkRIHyM5TGXe95RrAu3RSKVgSGoH1NIUr4AwB10xT9GQtneqLW5rHjrN4nMlgWZ1mDnKeN5tRM
qRf4Tl5tLC4SJIZhn+wWTDpbLqq9F5MuwHDbsxnAbVX1jn3GPaXkPuOyo2XS+Y0wUnE7DIYZJI3F
4oJCLoTCK9iKJBoDbVPR4AqhLe8Hnjc4cGfV5GFMFJKrlB4Xyh4MDbO+n2Sj7joPo72Kly1z2c/D
J1zj06kd6/ma0qtloGa8r2OyaUOmCrio7+quodZZshJdaau14hIax6qma6fLln+yNP8r6MP/b9E8
54/M1/CjKr+2+a/RvO1/+F9Cg/0P07bJzjimjzzru/9HaPD+IVxWEPoWISPT9R1YC/9HfXX/4dqS
f5OSbKXFf/4VzbP+wZ8DqLB5uXzLtMz/JpoHBOIXPgPEWU/xyrwSJAjHQmXg33/BmqJ80xUiUwaT
bhU2ARL/gBOZG6fN363L29bN/AsF8fOlPJMoIcgJ04SavKEifnkpGOfRag2M2aRC8ublJNbvLr+e
3bG6TkQMf60ti5esRvCp0zE5/8yNggD5z/tG1F/X4fzz9V1lq41CAen+57ajX16f9nOBrrX2QWrl
cXJvysQjn8A4+5CpEWaYkQKq4CtYkgzSJWEcupPYfHLV6L7HmRvdS8tvMTiC0y4313WD/8FscZ6B
NC1NALlZWR1dZgA/mqkBSFk5Ce04Vj66PKMoESJGLadd0jbVjznSzDlKmWHvjacmeeb68WIy8E30
DQ/7+JkDTL7gn6lu/HEx+v1UFcnLn7+Qn0sC/u0XcUlmKsvefhFnuzh++UaWmkWbDtJ+MKU+Au8g
LECjow2jaIHaUe7IPVqfBUDEr0XnIBJADUknbKjMWXkIqub7WiJQ77IkYniVFPjTWYZRv3fmjKyF
qlJGgV1lnsspFtvZsSgH9W7icjGPsZ33z1EvSXQkWVF8s4ekYYEv8975RKhSv86DxxGWOhFoHgaE
GHm9ZB7gdxgZgr9HHiYbFtrs3O3YTcGnmKB5DcntOHeNBFFGKQ2bfsjyg2Ao151Fg0eRDzSXBDb9
2hnC2ZGkGfKJ9pE4g5W0YVKmsxv4GBa+ioIhy65yFhSebpCuc7NSaRlh1ynvS2Q2Xn7iaJ3qPaFS
cz2k7ey6ZOf81A0rgBJPeN/i+F4RqpJB1HjJV7d1pUPeUtoY5bABjUTLyZIxVqvWZp/3W6an7hjN
hmJlihuw9kXkYcYGVioltNXN+DUS6of/4Q9WAMhVkCBap1xdj0bku5cOficqBADwx5RZlNgjPVVm
KLFuDzBwaUxOqTn78p0P7LDsPvIdlBiyUekDdn53uoliALWHNfVq9ofQOxCN4qqg3BGVLM6RUgwN
ozHv5L5HT6juMhM+AKPdjMyAnUyFCovMbO+kU606VIULhH6CooJ9Nhq76NuwWkl6sDBMxtQYHME7
MlDOpsj5BB/c3GeeKyrgIHTUWVuTs8LQZeTRnB4EAbUx/PPF/58eRhTuHnwanF/C3tjUv1z6HQ1A
PgoijTDa/aOTYG/tnK65y0l8gLqY+nm/joY+sCdm4wcO0Y8/vz7R6t9vPd9y2cEnfDj+7nYo/Pr6
vWnEaeEVY1BncbXfFldcCPSlV9IqzaM2/ez6z6/32/K4n08/32axx9aMcnLY24LMXz6wg+tM16YF
MbVC1epJ5AbtXOFbb7X3dWhm3EVytcLeRiRcGqz1RVOrb3qiMTzMC9i2kknOYcVeeVFGFv9vqv//
+XT+beva9v6AHHrgxxEuBdT9jb/9y/uTpfDnpsHM2xgR+8L8hQJeZdZ+EjnTZ2JSbF4kMnmqxtLF
PD1LM2D/AXa40uiPJLjF6c9f2L+fFpzVwsam63NuK/HbwVgZXSVoF0TA5KfBip9NuDndrUL68+ts
m1p+uxJs6gOL88iHqWDbvz2EzTq3J4zJIkj0BJa/6I1u30Sj8cHKCPfDmLcmaM5sh2YRmrgJ8zTl
pLachJGgOUyMu/J2mV4be1U4npy2gahmWAWVcxeV4aBLTNt/fsv/fu2yNIwCF12YL4Ya5K8/lWe7
tjtG2zse1/qbqXR3jNgnckjdKnlK0TaPf3693zbfukJsq5odiTwlhcct89vNiulZAwuX23i8sD6h
hPqA5loH240XI5VjNSDxUZoQA1gcsrx0xYD5f0IHP/z5jfz1mqBsoXABlgX8x2TD489K7tdrNFnt
2qzNjIV9njE9FJ4nd2Jka/WfX+W35cn/fBkAJDY4B8dzuTP++v2SiudgzEEfGXr2HxcGRSb6LzvA
0qFY3gerjg49hB6Em2IkZloRA5oJwEBEzpw85xFOa3V0XBtsUz/Lmz+/u78+OLc3Z/nsEFKWlB4Y
B/+35wgKkcT6xpsj6RidG9sz9vCEkyMJmpd4yLO9R1YkjBrseSiN3dN//+qmx0VgO45w3J+4sV+e
EmmLvdAiF8hcoAf21Rd6AvebGogQSdyF66yhuI+S+L3JfJBtHOv0N+CTv96u//z8bDRimMMSVdcG
jPGX55TnsojNxFcCsyqr1qCvI3Pa9VmDkAduDKt3QZu4dOP+zx/8t+fj9rrbGgjqfpuHpMUd9tfX
ZcMJC4Vq5h3EmDU7tQiYvBRxQ2UErxyWQea4e6Mj3WeXTmYH1Uwi/JDauKZDaOdrfUDsSObwz+/q
r0+Cn2/K5fDiHGU9hSX93x7aNZO9UfnGEEQ1m5Aqk9Vjg6DftAprvZQi+zvqzL89CfgWSOLjH/hZ
w6vfa3g1dkNHgHnYkMfAqdbUCCngzUNOw73PzbzYGa3XP5W169H7x0ApZGv8d0fpz0+9EfV4Evl8
eKyKf/0pMHE6hd207Euqk/IUo6rdqFaxk2Ywq+ehcNvtPPo2sE7uYLEkaJew8OXF72NxY4GuuupK
nZ+z1qq+2qPt/c0N8ttm6O3NAVrxlGApljJZh7f9ZL/cIYWOKWPbglWcMseIWaE9s01vaVm2xHAq
f0/tDL6ezLL1LpOzCeHKjSQLe4SNdqKqvmnwycQscWOq5SHQucnwBVQvg5a+MSxIUL4goN+JBcsI
FUEx/M0lZYntwPtXn/jz6zVN2+Ex47ASRXi/Xen4kxkr+E4TdPV0HzeEdFNj7hgJiwLiLK7NkMVY
PVOyfkvjg94v93AOcLoaRy/J5zxAS84vMNYgxsX0oVBcVMshqlYc/nD6eue9RM1LiQMzlAlBQCgX
i5aZvDqQyLM9gut8BCxSHLm9VhyW/ucsFvG1y8EU7XPDY0gK4Mu9T+DXQhGgOvxhJ37yahkzrquK
/MYKXaNmJF9CmSETPdfLOwZlCCf95MnzNNjlHK4liaEwyon1tJVj8+AEcvpmNZO4M2rTK1E2HayA
PWNWsqkEAzcoqjm6oeij9E4aE1NXMBvyLDTOF6w/EriVBL8GfzuvYRFqPA3BMJEn27XW9htXyzIS
Y3IdnEG0ILjkK6xW3RXctf5QpprtHtTo3g+vMVjk5c1O88kxB3/aNXSHcxh3OWENu2/aD/ZUuGWg
7NJew7ow0qsq6yjZY+zLmEeG/nm2lX4torT78GLVrPgTS5BQLPHIPhKTPuPMzWV5O9UtUA8AXUzf
qA1Z0LZSdj0LC/np4Kx4DE+qUARoMgGh7JABijN2LMFY7qqhMD8YuczfPDNJbunAR/VMZCj9nLru
Qp8BYPwGNY1NBq2GXYGyrCG1trNUhMyMAbU46kuQCRKKXg6znaHAro55Uu6meuWdcf403m1Rq/QV
tdrHU2Qu/KDE1NFN2SnVNuEsE/8ItIgIDHs28Iaa1bKS6rTVuWoL/HB48RnfAizIvy9Dvn6ywKsK
kuR2tCU5TAx67IUyg7xeRny+LPbi9yu67JOnl+FrNuK8D1QmxJuk+P1Or7I08D/K9YdDhvA1yZO+
IrMwm/N5KRYbThIJpefWyBvQAjANtDT9B6PAmRBivMuuGJXFNe5gvnNEvgkkZsVu4FsSQ4wRjFot
7pnP5b5vM1pMgCVr2nZSW+rKzj0nwkcsNw8Yz952L2s7Hi+xNdKDGuyDkcduNuKY9KrpdiFZYIdV
A30ODpHkjKa7BYV8ztAZYcpio+NjDJ5Ir5QDSjJMCSpwbUYNCME1SrbkoqObr06Zs8TSdqN6CpAd
mJHOTBoBaddz88Mq5uSrpxWiuT2vAw77FJMqzkhoQbsYqzFCfDEw9c/xFXtXS+tY4Nry3DiPi0yM
IE8KUvo91cS3iLjAvHPxT9dXfHIywsNis1chTxbKu0EJG8mnngHI9EwG4CmuCoEA4zgOxaNVdyUY
N9uuRZD3jtWFA57u6ph2XCe73OhidSgkGAaIAFq+ogpMGcyUSN3m3HnzrhW9U56kM4o+hDTn1PvN
vS5DCzvdsz8wnNq5ce7fan4jL6RZFwxQublrfsG0v24MnXdh7DCXJjZqefzBMpavbAkCh47qDQNi
tTPn04R3dwydftjW2DB1fbUU7A/2AXmDcQad4H6pdW9sbgZtvjMZrh+MsUGYHiAwOkcjNeBIwCas
Li1uqHKPxuM+aqdNi4BUDrcScSv/TRrK+9H7fgRssVqfdVkM2/c6b7ed8rvnZVkl7xs/x+bHJ7Sx
s9OYI7JzPePNtLdsYq8IcEGMtxVgBGb5hyZLbCjS7Cy56WNoDntn5avB3lC4wVSPDUpFTegImMPM
lr/W63Ab0UUmO5kP01O9cLyAMjC7ZW8tGaK5lHbLBbKO5XWamja5cq9P2Lrka3FRolnvMY0UT0JM
bIapC+bROHNbG60IioLGUspuvGDAMM7qF7s2mPNWYxJ0s2Pe1jpT8+b/jk/mul35VZfF34lvxUUw
57O4Srki/LAExGndmEQYi53fl/4AA3o0jIPXO5RzXWHR6ubd+mBMsvoguJd95i9YPzojYj6czU31
5pXthP9gzdM0xA0vyChjp0nCxbMwxCQOozSVCHgbcFvTRxMWyXqB7cCAmkRtdefJuo+wLpOzZQ+c
7zzOUbN8IrgzugHawfx5LPRcXy0dF8sJ5u6S7wmmk9WGUWF6YVcvRXGaTTbRhTZmhmFnTtP6gyen
eetnETJB08GpBmbDvDtkN2IPBKcWeI0nCOnQpxqSCTuhGcQyv2N9OHPUmL3kTMCtYbpOEqeDQU80
jlyidhjUM7org7adgUvVbF35Uq2rO/HwFihdAds0qAJHs7WWYwqNUd2YWIO3MKXObAyPlmvslQRE
FCyJ7eHRx3wQHbQYxg1fbgLuWcyECC2LRRW7SBx2lWp7OGDVdT4xJTQeVxYu9ee1KMnwzx0nYSIT
sWUSh2E4AhjbF5M2rqHx1unJivIGtlX7CCwSEgmZKqqnprthU0z3UbLj47PZTPft6PBvWLIZsRDi
/nM5/h+aBLrkrexDiRWw/n5rlJvZrFlMRqCZ2Ar7xdjncqwXNhyFQ23234XbPFmpjc83MfP2jPAj
3nnwxd83VfLzKKDg/N0bEurfijmUAosGHgi13Gq7v5aj7Dcmwp5jI/V9nmlXI+s9uH4mrb46noM4
6tepjxlM4qR0hUd8p27zxgsgY2afWHSIm3HyzPHBr1jNxGRcIGlyGzjeDtnkJ1nMTD5s6SRl6IPI
Z5qXeO1CFyZZPs1LLhSLhpF8n3pnW4mWTGDL5CC5mmJVF9+alnEv65l9dviktmucBkGpuxtNg1zk
OC7R01CamBonvcTPERfLVwDIsyJ6O6gfCKnirVhjdvzkfjOUP6POGIgJXM5hslp9EliR5+dMQinW
TzhkzPTixEDwi3TG95pEqn3D8wPQ3QRLyE7ZsWmRj1M2mjMxpDrqe8y7Fvq3cVE6A4IN+h8jiOOw
5KaYl5ytKlnjbHYQZu8Tp7EdWsrCV9qRFCZAx4PdG9v1K06FDGsNtki9cztfGKG0egjBNpVRiUvK
ZSkKRgaKHyoHfbArKBwkV3W0L+Kh+Tz4EI/DwXZrFZQ9smlQdX7xJSZswZ1oa7ZrSXs0j57b5T8g
N0QWvojROvSUXNzIQDagkfHadZBmQJkDXAH9nb9ujmykm+KaAwDLbSPqGtZi/j/cnUeT20iYpv/K
xtwxC5sJROzsgQTJ8ip5lS6IkoP3Hr9+H1RvxBZRGCLUxz10XxRSMhNpPvMaYK47Us3inujO0sDV
KbGy650gd/4REv1vS45vKxkWvSBB8x4pdPmm4tjmCsQBL2/2sVZj6qXxfDbRRIxXSOWW0mx20BtA
bnEUqQ8ia/SNYtJK7mxQQFBJnGnzmcZ8cl4lahpyXhDVsBupAMQ9TIFXnNANMOGltSACBfIrly+H
t4ULyyBZJzWUBpqecnESiwFL+7jmAcvg8X6zC+gGJOw42PAkfnaqCJnyyUveXx50bY1RiaWUpSMU
i8Xl+STpblRdhDravnbC4i5xkACLarW7mUKEhwaAQdfI3Hqf467AkJ7s+O/nPONvEXKiu+JwDZ0P
r8DvIjsPGD4H3lvDRjk4fd+hhwgURQZasVdHaKWX52ysTJp6rv5SFLGRVl3cwrHZSTQ1unpvJHX3
C4cKnIaACnIN9xjYNcdGAfUGa66CAJaJAQUbzwnG56BBXWZfEmRAA0TNNAMePPnHEgI9mLukbe/x
WRQoncqKuNdEWaA5xoWmPKlGTeSlQ1SbxgJQQBDh6TjF4yHOHePesZBPAc0JrhGqUJWLvVV3eUeu
bw/FDqRLgmCRnvmuTecVTewS2wnXpwFWn0Dg1HSTVAW/EhVvpEOO25ixcQznb7BI96Whq4Immg09
3lxUO6l3yxRVw36fpqn+B9y7j3FdjaP3xjjzv7Mch6IhUonU9VXqd4u9wMhoOXstGgMaiCbiJSJV
TWgHdDfeYzXM9USgWGENVPVbc3x71gWPrS0kpWxbCLnYEZPvAL0dUEAUeqCdHGvoD74Z2fvCmXkd
kdNvFFFWxjOBD2BYyqur4ip9Ple1q/IJPbwGsU5neuCpK4HCZIP3ruHEY0tET0HZWN63n5E+FiLC
wqCDI4Q+H4pX15lskZaTRfPivlPtg8amo85+huF++XS9PVwUBqDwGzyMwBVe6l+vxtHavK4rk1tb
jnX4yJmfjURJKXytUr61KTm0Rah3TemuOxipEj1eHv5tcYokjfIjdVgCFDKP82mqKn7nageIoBsa
+9i2ILW1thj2qarm3y4PtfIR0RNyaATwSuGUs7g7VTixCdcyM5XT+DFofd3DQ0JCm3SIqhF2qr/8
/YDQVOePR7cFkMn53DiJqlLls7AM4L2jTYH/CvG89FMpBZA00Ucb4+nzk3N+JCGQCJ22Cm0Ozt/i
SObZKGqhsmeqlLB9H5eZ0ey4BjK3RLL6pNXoPJ/ivh0/FTCygKuWjvlFQalsdk0q4QaKOAqKo5OI
9iGgZAjxMfJNxOmtof0QNYoVuWqB0s5uxHNcdXu/1rbq8ivb0XLmFi43hcQyZbFmaRvU2mhQuvCp
Md5U7RAjYRaSaZYWPFpp+f7N0CsGhhyRAUEb9NzGeXj7rHOpmYA4rLkuTn38/KP5FGvaDNGSvawx
j63s1DgN6ljgex4LElR/QIkJVMHlnbJy2LlJddUygIRY+vLOLhzEL+oKNdUBfC+GFjHFnCCaNlpN
a6MAGKLZyFmfy+2LqeWy0QBQNnsBu/R9RYQE3F0Wt5fnMv8ri00oTFMg8EAUbtHHOB+lIvBr1drr
YPna+VF7oRpGBgk1vi/knJXY+GArN4gkPLCQ0AfWxa45Hw+qhWr1lU1uq2fWrQMh+itiPOlRQ1hh
683TVtIv6RhS0kg0eIL0xXXFnSEpSUDgJPn/TiG2ugXpRwmZXOM6LBrQn1DOHqmeUm5uSii9YaA/
dJh3HGNVgEX2u6RSNxZgpYkD7gIfPoeMDuiRpZ+vQDdVThnGAzh/X/HeITdeXNljlH9ptGJs6UT0
4mAXXqpiiRJGT2zw2c8HqazL330tWaaNQ0uNuAPIi1w8klnjGwGqDqSmbWlK9D5M/XMdp/rHEi14
LLOrWnmSMRpTOxXZo9921TmIJ4aB9pO8ANXZHDtO/3D5R62cZpu2rzY3+XSWaLE0dVfbKc4QoDQU
7zkz/fHaqHGzU7thOjghmWEPLGFjId4GRjMchEYL1S/6auYiEbETxU4GPwAjnE0Rfq9+4momsglU
Vsu95J07TMDC7wKUQ37+9WwdjcfNMEhL+AWLo+cPvDeRA3u4xwvoMaAD+k7RxxREnPCvRqtqfiRZ
lD9fHlR/u8a4YkmNmdrzG768VvIw9ecKE9eKyCskV6wWl3RiNkhpNbED9L24aSdwuA7tDo+4t0WQ
BnD9HezW5iuY+QifzsIMsv2oBjoqsz5WGUCsWizhqQ33EcXAQnsAGTa+b2Pb/B00FlezoXnUZHxr
sI4TPEjE2YnmxSnoQx1dLb8e79PJqzdiiLeXDSAEAhYVrApHfVl+wR/SRjWSyhv69ehzmYitEDTW
oNzD/Pryur4Z6iWVBk6oOxJQ6gxmfR0Axl6EiEtuT/tUbz5NpTKc0HKz9kUQWH+7YYlQKCWBQFBp
OtjLQxLaKfJ3PVUu6uGh22uldw01LNuriob6Rq15sECL+oOhZ/Xx8hzfQjPYrLY2A7YswzL5DeeT
xL7IsDwP6p0jEvUjirjJzhipJle2yK+mcRKPSQZIT5lohNGGMB7qqM7fa2C6d23jS1jJZf1Q5/P1
cfmXvXkrBb+MyjNneMYGi8VbqTqpgcYe9vAwu7z7wG7FreXHxs3lUfSXhP3stSR7AbE8Q4Yl1XNz
8Xrhnq2nZa6jiZEDyzuGONrgMyRxMzpImpvfGpnk39QBhPq+tgZUkr0s6mk0GjkS5yMlPwTTaPIl
CCPxJu8g/FXfnSG2f+DwPWiHIMOr6F6nEpEd+lhVPypK2b1LkSUtAeSrER7I0VhOrqdDlaFsqMKn
05BwDK7NvtSRvsr9Bj0wkMb0a6g8BQd838rqqHWtfY/KrIdrgaRGvFPjgILiaIYqViB9ReIdTzXF
QhjvT7WmgczU0wrEkSlTJNtFSxESrctCfsqDBK3gKkCD88YvZx3wvmrrblZRU+tr/H8RERVYhIwI
KSgeDS/uesUtMBSor1qaivJDao/ISE8+G+KPUfbWZ6ccul+WnU/ZVZCmEawaaRRAARHZDqCID4Vx
JCmn3VQBG4Y40XWIfqO+850+DEKineKnhM3tQFUb8kuJIBGkeYQ5Ug88slT835b0EQKuVYQsaGyW
5s+wNPV8NzZl+xTnnvmHdq1+Ow06gE6ligvnIJAUzpDeSLJ72idadDNFMZxMAT4KlI3hNx9pm8Fo
VslgQROML2owYFDanSrGBMvvrCbzk6EgJh96A35tbRbVR7xLKxXtIrDBrtU1IE37Jpu+ZEWmfrbr
oHyiFYqYNGpUaNzREoHYDA609Ny27ot3aCL2P2EXDSqc02r83kzeLF1QFulnpS0RgA7ixsalQMQG
Mkhkqylah7rqgVPr0SXoweAiYzlpMUIyup9dqWCEqivqInaCd26BJBU+n6hTSWVAyBbwNt38Mh7x
NgZTov+BL1rhhVyhjUX2xw2HsJBiw6NVtQo9GisOdk6v5/fg5lBRgaZKtzBN497H+SSbgRY48RXX
ZVOg8AnGDONlM2pb0/WCTIWS7/nSOCGlPfwoaJUad8hnOUcVVwHz0I5VGSGwKtBnjUKz+lZxyT3m
IrBz9L3L9h5MUPY1ChCkaWlt54c6GbzWbaFkQSfTK+eDg2rrp8gZMC3A5ML7odKL+1FPXQ/RCyTw
t5RQTWAXok1A24F/gqMJIQuhVl9alou/F4h9RBsVt9Ko+oIFVfTPhkW/sqqm8ie5TXudxoaBlAiu
qLEbQPj6SSSN2E/doUGYmRNmgw2CoGzXGkYKpDRpl8eAViqfeFTyBF0BGpE7xwawjHobJ3IXpKXz
y8pF+S2ZqHYjNG6YwEB0rbjVYIz+HvvO5yoQQcd5rkUQo1UAS3SHmyZcQ2J+BJEMQEuI29hWpx5R
KbPC24TY84HMxkP5XMnBzpET+PrGE/X2Op57HRgyOQIkCxqm5+9E2EBRCnuCfBNxPdT8TSgNSjFt
PUdvQjcqSpBEHIpK4DCBhZ0PgyE2ZtEC6nDV9vQcK7bL90RDcTzwFPuGvVQ/6ond3RZmMZ6SIC+f
aNSzZ1C0hmEIbmtC/uFqGEGb6GBXTrRhn2DiK59zPkO18UStPZ4SvykIJzYNoTf1BXyE647WqLqH
Uyyzo69n8nMmbPoVEQClW7pmESqAYhg+cO94H0p6s9eo14Tv+8yP29sZNCToUGjVV7ogGJ9cfttW
4hfyd1Va/DrN4Zk/X0tC0CSDtoFSfRoZPxr62sh0Z/gB58FGBPo2AeKzEe+CLEZweYZrnQ8FBCFP
EDCA8U2vFGMaYPUEnXb0m4KPeNdihXfK29He0yzy74NwyG872qN/m/fyI6iIU58mktEAjJ3/CAvj
aN5MgGKUXZVTP6LmZpfDk2E15kNHv3Ajs3mTZs/DkfbSZ9HYscs5Dx0FVltS5u2Cznjw1TT9MZhT
DDFwJh85obd1Nt4UlxiQJBveDOEa1JxFvwNFOMDLA6U5MfT2FaDZ4lOuQa1LYFOiSuY0V57jyStk
Ou0PNd2oQwEIfqs6szZrElyiJV1Hg3HZgMCnZOyx04Tz5FXdk1FN8tmKot8gs/EEmTzt69/uYeZM
VEZpwdSBpizmbGtJLGMCwT2lhfo6QbsC8FkqruQYfNwYaWVmGjIxNkBM0jddzsfpVR3Wc0YlMGm5
7qllhOE+BPgxoOdnorrVO7KFgt7VT1QdEv9kRhb1ZwTBwzscpnnZOdjmB/w/2q+hEukfGySBmx2U
kKmFOlton4WiYTQ2hNbDLAP8XgWiiEyKlUIwMvKKcoAyFeoP+PVmuBfg804JRcTPWeEEz0hE+iCb
yJJv+y5z7qews4OjbnazymUTpY+IZo/dTuCTJd1CK6fTYDlJ6EYJgqiHsoqy51FqQXhIFaP4YSF+
i2jJ0JukaybokkaBObsLUYfT8dhQ0DyWht/9oaqOYrxew9DcNz3uq/cQW4fyfZcGYChR1wzzo20A
WNmXsP22igZrn4L9JUhqdT7GMimhqdIIyyjJh4YEdTeh3w0ps1O6HhgT6Ihs46ZcGY8rg5ItaR7t
tZf+16tPjwdhiDUNDpvgERu4Ylg6A2qSUKNxsUhcNDLVrRvz7eUMT4cmqc0EHSgsi8sKYpWlaJwk
ILfT9DDwnu38wsgfQJnUz3kTxMcgrzXE9LTxSEGsOmhk1LCKxLfCUccrMF/2oYtwZImQGq02rrbV
H8c7r5H7si72ooyhlD2i+yY5UakN4VcjoOUfNZ2kfiXEtJFlvylekH7ZKkcbjAdd4yU3oGnTPlAM
yVgO0hNhWZZ3RTuptyA0cfVA3OnkYbi6MUF97YuTZxt0MwkzpL24V9o8wv7LYoZd4MBZQqpAeLdZ
LALzWJg6On9tjdnEUWJB/BU3PPiNiAiqO60BROgGsPpRMM6gSiAVQDlrV/kIgha2ZyS0OKPyK/Cm
5iPC0ea0r9CHHY5TWtrv+DdNeaAq1x46bKVQg8fW9Q+wWrqfrdI19kbM9rYgSFqv6xpiH8SGBp/y
/ErrOLgDmv8414m2+hJSjzpSmsbyqtAy5+B7+DABI1D2PnZK+yAxqA/HSmNCfhH1XVU61dXlO3Yl
iOT34OzukHGr6pIjVmmF5wA8BuGUFXFIEEvnaUdTzN/I6mEML0rgZPK6SehDPwsy8rI9iVsbcjV1
3+9VfwyvWk3NkcUGZPp+lFmPbEYGABJUeBQ8T9R/kDTlSUVwsE39Z9wLzBwfQyO4Rq7FwiclF+kH
ldBC3pQm0Tcpea2hCCXH4T11o+FrmCgqYtxhj1iMWQf45ABDQQLBo316i1vtZKKCLPJf5L3a71gf
JKm4amUf4NhGd3J0gsc4AYa7EwpynEcbnw2N+NErv2pTAeA9lmDA9oCIxJ/EKxOcOhHq52jokbXV
8nypnp8VQ0DE0WTldaecb0LlPt8wfiNtNOIKVF0DB4VooUBcVSbP6AHETB2oPal9pTSnf4B/7zTu
rOuV3mDXJf5EiY6sUWdm/ntvimvziLph3t4p3pA+ZyNUZXwmJWUKh1/fHmRdOvlHKSMsEXlRw+of
RsNfMfL//7TUnc/M//zf/+sfTJD73Dz/j98ZIM3x4Tn9/V//cQyz5Dn79Zq3P/+Ff3j7hvaf1tyx
576DuS/0+Vr/v5a6Kgx83TAoqpIWE19ycLOcUtV//YdU/xNFLRUyH3kOf3tuT9d5O/+R5WDRS6+Q
ljzB/wzT+/e8/XnT8BDA2HcgHIEfMucb+9UbbBh0apwM4XO0CClQWYnd3zRoL312cqPZeHOWWSYB
BB0C4lfTMlmHlybTq7Eiy0/ipgnDA+AK80fbpqiMJqkw3T7VJDUnJctJJCXiplaWxBtNwNXBKW7S
EQE+RNv/fKJwAZCV97XgUJpKeJspMaZgTmm4Ji5vLn3jfN/gAnJDd3rYCHPepGkv8wY5BM1sbhQt
KVdD3yLWBmLj0KpJ+nGsRuUU5UX/MPSF7GCRG5jgjHSAgexK/RprDYorLSKVW79jeT2//A6Ha5mC
gk3cpZ8vgSZFIctEwh6pw/BLYuYB5Thw0ezE6ehNZf4nRSd0tvlp0fsKoQAikoZ0B8IoGy/Fm34i
P0UCZ9dB6syotSWeqwmonkYF/LOSVkl9DGmSXAv8g9F0xW/8Uelrou3R9mHG5ehHX1tk7pS+K+Ta
dlIdqzuY1qoD54Zi59YyLRO++bch60BRHukZDtkiSBkcBENH5AwOpd2HH0x6ZrPNz7gXFT5bmIHU
pwR8z62RQMmpS/x6Sz+v/9E2+W8xhdrKtyIu1jRuAASSuB/Ov5VNShB4OCUcAkSs35VhYbrGVCFO
3uKFIhN6r7ALoK8i3RvfxUGM3+8Afv9ZisR2X91lj/+8Q/8ja1NkWLOm5oJhqNev07weDmLfxDJz
mm9yFb2+IsjBW6DHfnwAiq7/qhIzRtIMo8zGr7zT5aGW8eFiqGXeWXg84CVcw4OultTCR6m0N/C4
ve9WOo6PcHXk8fKA86lfzG1eXW5nQRsCHND53Gg7RAqctOhAtE2nwSizW9PE8/ryKMtgm2nRGobl
DGISAaKlaTmWl7qiYmZ1KHu0HpvYKLjnUPLBMguhENt6lrEpN76atvLZGHSO7edbh5rB+dQiZVTC
wR8inFqS9Nim8fgYoTl+SBOl+W6i7na0iiHDpVt1kHLDyGbfg3+izhrKdx5w6isNIom/07G4/Dyh
tJBvnLO3v2+G6c0vn0Xqp744vb96DbijqKC2gH7rvNFPWVnY0CPC/mSgW7Qx1NttRaFQ49KD6Emn
b9nUAsTf9CgjzF8ZBoJShMCN+WGf/DLp3AnFsHeXv/fa1ObgH1I7dVW5pOKnQz7VMH6xQAa8feTu
t05eqwImKzAs/fuhLJI45sbbSqxw/pXbuGqoevvJwe4cidgyFqVGFCTHAZ7EVl6ztow8HDP8g+oA
lPLzsWJ0BGCfIAOuxw6KUKmpjDd51w/Wzkk8G/8mYBc7Cr7Gg5ZX4x1iUyh8ge55AQrK67A1nccS
l9ZvCRzDQ46ilDhgrLbVXHxz2mYcgAAPAOWT4vlSVkAvwCkpDYpWKMZ4V2Ar+F+jam6HE1VOvivl
lZFbyhaW6e0zP4/LqzZz7WnGGfOueLWhk7hNYl9vLbetGqdyp6rWP/SWkVw3aDn/NFpF+WWNAzqm
EmseXWK+AaIL5+O/3BAvv4IgB3g2mfYSqSPC2hgmv7DcwYnbKyjCwROY349+Mmkbd+ebXT6PBHyR
A6UCD33BR7yarxZ2rIYHQSbF7fODN7bOXWsqNfLt1Ef+flJzqAC81WIwe1G2KVXhj2j4W64+muMV
gifGXrZRhe5vYmzs8rVZUfyaY8QZTLxEdfiFYtZ9qLJ7wIzsA1no3+BhRbSHuvDn5Vm9eXxYQBoE
iCDAH6DOukj7kqSxqwlql+s7TvWst2HyQTMDsbF2b04tWTeMf0oRlLAhmS/WrsKbSmtrFTfYPqgO
VCTkkz1U3R3+iR+a1h83JrWyfrMazQsGbobLL4bDPm2A9mLi8jgWGmoOQrocQ/tZgRKyFdGujuXQ
BiIygVi+POlmXfdmmqGLrLco/Wi5Lm/oDf5AMTH+fPlTvckeWEQNnAigDZJ044We9GqvN1k2sts9
ZtVSXjq2luG/FxpFhh3Cg5VBBmNDo4sd5cYWOA9eHnztZqGzoiMUQetDvIGc11asFzXoULdXJV4O
kYlZdNiYrmIrzSds39JTIyNkp33uJSjUyJA7yHl+vfwr1hZ7PhTsImTm3gh2DPiEo6qVW9SuzUal
AB0WNxF+6qVrqMUWQGZt085hGU0+0lJAfud3qZSl3sNqsXCKAdTug+LPd70FUaFqO/rCFl3z8e8v
Tvod/2/IxUs6BCMkzrG2XMfsmutaS4dDA7XvnaeFWy/p6m5Cco9QECE58onz2RlgXoKkTLij84y4
C8hqeUJlC/+T2JZ0CBqBedcgqy+K6LWny59xbey5AMsDaXB/L2PRPDV6ZGm5DvI01O4cp+8Ovq6l
AJEq4wCQuj9gffMMNTf5++eCEhdFX5NKCCnfIo0YpgapyAiEW1ZJ9SSxv9gVeWndtdGUny7PcW2r
wpPQ5iaxicLOYn0z08LJTxTCFXnzK5Ox9ZiKpD5hl2JtTGptn9K8gJOEhiIx5iLIVqjd5rgnYlDD
5ep2dWc+dkOl4PWBa2KLaPDlib1NC7mH2KWWMStwce8tN2kBwDWBY+7apRc8Q00vroMysm7xr8x+
OMXUfRoRj3SVHEGTEFX19ykGZogyh/VGiPumCa/Ov2TGsM0hD5NfPF6h0+mIRAlAHTHscqVSxjvw
OJhZV9pTUUyF2+PPcFualX+deYp0kYBT2WSws+EWQSL3E2i8Fgosl1doJfjjikSKEKoYVTJ7/mCv
Lmovt6zW63m+Y6XtjxTEASmrvrGrfWKGbhj9G4c+6ka2vvKQnw26uK0wdECZjo6qa6kDmE6pI2RF
DW/jGVjbaxYVb1jqM89h2VZIaTOH6MILNyz0L60MrdOEzzOeDtEdkNDs/eWFnI/jWWbM96WfTzuQ
+4me4OIMjYrew0DC91LFbhn0mK8jCiD6h1BDFxn9gOHgRzgBGYGE1uql4ePl4deOsIWgmQG4FmTv
ElSNfkonp4jhS0A4rleHNdUftEesMMj+xW0BHpeohSI/elnz1321ZSYI1LWZMFSRB8MVdZfsgIxn
iTDhJnds9RPOaleowRHGWovdaXkxhgrOgEZ9j6fjkPn6u7LtNYQ1msQVBaa6/2IVX4232Jiku7Rj
KGYhCa8gukcPYg+nAAg4RNmNoVanBmAUfvbMZ1pmP4jOYE4ksRP269671Vuw4LuoLPDMAg7T3Vtm
uEUKX9si1DVIR7mGLKS8zr+bSEXrBY3g7qWouU9Rjd6VHn5X6Aekx8vruHbAXw+1+G4lrNOWKQk8
63ok47DGcOsy6zaqomtHjuY71GqNZoCzLFHXNT12GCMSr1aUqKlI4bYYeyg90eRRTxaoNTcpHO82
R4n7WQdVPm18w9UfMJctaEELzVpWPpH+HGvqYAhjN/QB0KY1oVB2nfM7zU3lEGWcd2F0ylFRZmy/
HcYbd87qF52/JPRGmgTLhCg328AhwJtvuBblDKcoUkSIAtv4OEy4a208FauzpfNBKGKDqVkexirS
kgxNUeHqtYbCiNe37yZYz27Q9Ei6YwNy1DHavJOFhmqrNZTXl/fUWiBGyQYytU2WDmPifPtqRGhZ
a3Gda06QRju0Qp5aNVI+apbXHPWejxt3xUxpq+uNC281n5grg5SnZq6ZurgWBlm3ajW0XAtaO/3s
TGSbIIflV/aLc6U2MGkcLdCjwUm2tipsO1EsbDY229qZmuuhfGmaMlC7z+ePRR2a9iPEfooq78rE
w2HA9/pxi+e5di/R4aLrTaMBuNy8C17d7knU4g+oIsFuqTV6P7V2DOj/74bEhI8yqcrGplqd1ctD
AmZcJ2s7Hy7PEmR5mtFya7OK9tOgNDdiGrdKL2tbd44AwIiAoScYPB8F4xLsYloS3xKUkoE2ezXe
V0kcWkdgYlCP61r30dFCjdTakSLPqgsyGcLD5R28uo8oyxiARgntIWGd/4zItumQaFTaPBwVv6m8
NKhS9dmNkuOznvsDnmTYGB5VFJawAk3yK6NovY2+3tr3ff0bFq93rUbgcGvck7DvwqpqCqo7rU71
K1yr8ZHAXufq8qTXPjA3FFqFDqANijfncxbtAEzQRybIRJXiKrca/cqhpvnx8ihrNyGlBoGWOwcE
5O/5KD22Ld4MfXV7CvM/vQaizw6Aa4fvI+bUW6X4tasItAq6uYIiG1CE89G0VjZjNhG/KkYEdDEC
7X5ThH0SoOkPb2zXaLiZ7DLRwJtoIP067r+YLXEDvUAuAxox5+ObVd8lSl1RWrB6+1jgy4u5RRbd
2OnQb+Qt88Itw1q2Jbt1lh2l+X0+VNyPAEVLCguTpaY+8luNs5cKpnWopIlDmET4t4/pFqtmdVSq
b4LSOZIBy00z9ljFB3OptG6c4ToX8afcH3Eb68P0Vumz9LZpzC165NoWgohKIZjHZb7/zmeamySj
L8UxjC7b+8pXJ2zkw+aqQ6hp65JdOxRzQEvZ3dCowy0/IEpWvS9R5oNonh/RdY/ve5BzG0dvbZvO
GRvYhxlHsZwRFFKzRfLKwoVON/5YgDN7VPSb/jSGmelC8gpvmgaRwBhP8Q2Q8+pigosnOuYhoQh9
vpgmBFhM3bEMQXCnu66DBL8OVuPGrwDN//1hYIa6RgRE126JFnA0FOYR3+RxhpByGGXzXA9edwg9
GPx/PRL5JB1mlJ54iZeXTNUPtJ/jRLiyDXGTwkfrputnZzVTtMbpX4zF80sRWqV4uLxial/rBrSH
hNuMCHo1pqYcamGP90FMdnl5qJUXAYkI0I1sEQvE9uJbCTPyGgM9I9fPW+V3hPnRDrpb8L2tsGIo
S2w1L4+38hhjezDfnyDgCasWL4LU+jhUBVeKltuZ8q5PFfUTiLtk3CU90qM3UVgk9nGwK/NdO06Y
cimAfL9d/g0rB/Cli0olHI42Gdj5/rQT3yBYpvLTmiL63DntdKgB8P6+PMrKKbAo7KPpQGGFlsLi
va8mslcddJ4LbQgMTdOHP3FZxaKHMGQjF1obiqYmdQdyZe6wxaImOSa8UTiYru0EqHfapXjMfCIb
oXbt8e9nxdsDsx05Dh2ow/najSrV5QHogyu7Yjr4jhdcx21lEzL54UawsvKZ5j6Fo4NCngPw+c9f
BaNCVO2kdKbhdkY4HIMwkbPRlr9xrlc2JMEYVz8dLApzYlGUNFvbaGOF14YUGccPiLuHsR9JcYbY
29ldn/50lPoHOnPWdWvhuvrXywkVBRINjw+xwFLTobIlYlhUWt0krYt3md73J6wmesxy8Qu4PNTa
coKRmTtbdNvR8z5fTt6iBtNfek3oeWtXdtnhsQ1OaGM510eB+AGkHhL0chQkyJuCjq5JYJBnV0Qo
+p2ttcnV5bmsbHiybkhY89XlkBWezyV2UEhJStorWGQ2R7yPUcAtOvW+k9Hz348EW407n9caB6/F
qmVqhZNuSi8rq03zQc1GHeZWEO5jQcPz8lBrOxEaNwpx9PqJQRZDpVlGa6cmsMy0RNsZQO3hJyrB
lRLIb4aSBObOqCf1CrmTEMYG0JONDbK2qMArkTXhap471eeLimwPSK+MYD1LhXpyhupzbuZUMgNj
Gr9cnuraLmEM8Joa0AiCrvOhVC+L07TkBjZL2J3wP2bOaenoycaU1pb09Tj6+ThxofdlOJEZiLFu
n2RjhNfTaJduIqPkWMqpOXVpAYVVyb3d0Nfl4fI0V1d0Tn0sOPPUKBYrivKV6MFLEz/jJHSnx7by
UarTiDmL9unvRwJ8N0eVyM1h2nA+0WGaaKKEOv24No6vwM06H4KapF33wi0plZXwnPnMbUZs4+bm
/2IoZ7DzpKb1F49F8gtfHPXGatT42QffcAM3M32wBqP7FweeHgXt3Jnbybt6PigicnaC1qvljlEM
RxX5MrfL8FV0AB64l5dyfiwXSc/83MyFFiCXbNHzoQZDK6rJ6EwXHwdym9hrmxM61sltgNX0sWqs
4rHQU+WPo6LVfHnoOfBYDs1jR59I12a012LoSteLTkG6AUFGXT+lOf2fTEIP541AzEjNqo04c22q
RH2UNvBcwXZo/j2vXlglFM0I1JZjGOvWdVcFEkaqhxym4denfBj1Xd5kmLYGTbtxMtYuAKTbaYrw
UFj2Uv+nK52gnDh6LuOVmIsOuC6qTlZu3N5rwxDazqU76m+0kM8nWOIoiXfq3IaPU/MZdXrtVCTa
uBGorJ0IIghKsKgPAjlYHD4MYvzR9xqOuVk+5mlsnVCoVk6yUDJEr9GNjjxly9dtdWY8R+xTMJnI
LJ7PrCmMWjdDZkaTMHF7vWoO3eT8urwf1ybGYyS5wOhUvOGcdTlm5jSWpNvoKh0YFJN2uomzDeF6
vQuTtNi1ebhFCV6Z2fz4IaU7C3VCuzqfmTLChFFHReCg0bYY/UZqcVsN4fD3bUiGwZkOHTHaw8tS
Zxj4CpbalO9trVZ+F6OVfNYKOf39PgcuC7355ToBwnA+mSA16FHEBlljIZQr5AlQQC/RH9jYgSvv
HEB1oOpz3RZ02eJ6hC6Vq1FLV86SkfmQacoPzzTkfeEZNwkArXdN1X1XBye51SFmblxaK4+c5Bmn
ifVS2lx2lrQCjESKjoIrG9+5zerSLrhPBLLo2oDC0+UdubY54FvS64RpSya+uCFL0eIgHc5dn3QE
H2lrZYdcQ5EPG99tdVIsJB9Opz++vBm72vdH9H2lm5fFb+7F8uNExIJfebiVAazOCM7mrA7Lo7oU
HDRxGwQGjfqnNkumeI3So5AyIaC3sXJvWQRMYy43ETATmlPMPt+KeBJQxSv5Tipa5m4BH/6uK7L6
EI6yu0pyQNlu0mPsVIpQQz698/XHTtrFTOeZTRL7BJGOWBiR717+pKt7F3kOSiqwLSgunP8uTYcW
MLWadHVe1e8xIi83DbZTT5SRhvdoZGn2DTki5vWlocZQj+O0KDci75V3F/QL5/SlpIvO8flPyKMS
ReQYm0kKasZ92qct4CKolFElhmPV65uh9srFCsnQnP/jcjCXobYWWl5rUN6ghhvY13mTK6fRaiu0
B/zxax9kcMnh2P6LPU3GPkPSCOTZVOezVCNRSyUFYhjXYvyi93DCcUZuv6fkMxubbe34UJ2mHof5
BDfNYq9VqCYmMJS4E3Sb3pine/JPrCdYdbZlhc3v5R20doQgKiPqQBGQRt0ijOlQbIt8XA0odWp6
/Ij6VmEdzVKOW7ZxqwPZMDyAE7FLlrdCW3WTQgIlXW8q3slKs3+WRm3+uTybtc2IVyCVffFSjV7M
xm+EU3lYvSDzo8a3VhZrj14ixR5j+Dbb9Xgl/IuPZVJlnMsPVG6WhqQeLi8OEELhou8jjkYKqC6K
m/bYZl68cdDW9gU9ZL462plzeeB8C9Ko7rSUO9D1FENc11hPYJBcdofcRgnv8jKuXSuvh1rsdqMy
ZQ49WLiE7fGhEXQtUH1+ahBdcqHBOihiadNMGELFKZLFRudkfaKOYDegugI/6nyiY5Wolq+YAIKi
sMbPefQOQTQ2x7ZHaOfyRNeGIh8jXKKayXec75pXQfwAvcnqI+AWjd/V15j7lh8c3ObRdEm7jat6
9Q1BfhR6EyEnUeHi+0V+Doy+RBGiLDXPuq4SMtm9jvKxs1Ps0Re7rvS5qQefivKDmPBE2acoMJU7
MQrtCZD/cNKzsv/VN5hAHS+vw9rhRB0OfABS02RRiw9eF51INGNuBZhp8XnMgX2A+/0XOBooKpTR
QD/NOeIiOvWDwrNjrYF8X+FLJU2EENRSufI1iJiX57P6XRFinbVxLKh1i+9KVD5YKFuxhaYuwy0p
rcIK/SANE5NY6M6Gv9r6aKQSGgo5ZGbzn7/aRbb0c2dI6fxn2CI8OZQKr6JE1T+lmR1tVKvXHj9m
pVE9mOmty4hHhWoRNOkMnAn68qCT9bqZ3VOy1keEs2Q/3CAtp3y+vJprtyqvERqGZBQzeO18ftqY
Babfcslx4IO7wcIrmfu1wBbEqVW3qLstoNzqgMQlJE//KBydD+i1I/30fBCuovnqPlQ050cp4c51
tRF8DXJjq2e0uqqk0uiAQ4Bm3PPxqq5SnFGl6eYnTfOQGI31WVPS9gj9PREHUYYoQKGkuBVWrp66
V8MubgSrakRTFpyHoEedpQqTgt5YkW6chfXF5IECAUOfY9kKSA2h6IE/sTtJNsg6LW2kihYASIHt
EnZYjIWxt3HZrZ0IdEqpzQM6n3tk5wuKS1bdAfyhixmY4qEeU+Pg96a8R4B2y0JmbRGBh8IUIFqi
XbsYykfgvBvoSLlWGyJoh6NW4Oxa5Di2crX/w9l57UhuLN36iQjQm9siWaZ7vEbjbog9WyN67/n0
/5d9gLOHLKKIHkEaCLpQVCYzI8OsWGvvkFDbYlqXSJb5oI2hmQYUpHi95SFGYFqn0uyYZVbGuvIn
taDdkTm2DzFv9+3x5dt7i9GCAK1ngqEiS11vZQ/MJ0xJsryI6ZZLYnfdf5YGKUMnirVnQ5PMswmU
wlWZt/Ehu3j9ADWmkX2m78gIAS/lxrmFNtV6PjIQd3XsDXIbpfxgQCkP1fTYKY1nar35GfgQiqZ6
P4LFHEHLo7neQ5PsmoOBRp4xk4+cJFnNr4/3Zu+TAFHHM4mg746Od2GcoLYzEX2VmfYGtDfiEzaC
Ek6HuuyJyW/F02Kp/AMfbIHs4C+cIRDU9ReR+mUYIVCwvESTRYGx1H4l6ZQ8S0O7vCtjqnGVM1YH
S90D5ON+4XXgrJNbb1m4aUxJhjYj1x6BBztrcYFGSNFEHzRztuBrLNvvDgi+NwXvnp8sMpyecxB/
tVvpCO6xd+HEcBKHAkAWpJTr5atWZA5yR40JKbHgQu4Q+oWsHaWV+1YMwWZBy41+/tqKNGUAe3tS
e3OE41lTUd1BJVY68FPCw26KxhYPqRB7op0O4mNtZUokTWtEvuCMGexLYHwvCeJnlzFRl1vXW+Wp
DDLFN5NKvjw+unfcPYw1iJSZyyXo8DlKa9NWr3SLXqU2VtP+g2pLMpIp+fwFatSx92HOLPpLmmoq
4k6GPb5BMi31pkl88HwyPug1YvYHD8XebSJ1Iq0mhKGsJx6S38KYErlPiG4tywMYOv/UJlmNgYLZ
PdKE1TIFT6UJ51yWqOof3CdSQoqk1LNp+m8OlFQ0YTqFvQ05Rh3n72un6GACtYz3aaMR1QSI7lgf
KMp01R8sWKQZKpwoInLbFMSIs2KjHVnwGASO8VbtLOujWiN/81GdavVDOneN3xq1dpDf7DzI4P/x
WGByxfyuOPq/7bNeNTPyoLmQR1SS95nK/YXFNP+nbaSvizEUB+Z2HhCG0slPkTOj/Gera3NzWqY1
VSkOWq+ZHzJB5Tsxd/pDm6Jec/V8Gf9Nw6a6OMjVAjuXjAPPtbdcajUvcwic8y3ZG0y7KKFnui1a
s0F1kgYb+vCUguqPpekdEV7Zyz8Hl0tcns29Jh1Hdxz6NeQetperyeeASdfOgly7ir609aBerDEN
PzCcY/4Tp0ifzWaH+iwkbT+1Weu8QE/Ug9O141v4DWB1EJwA/L3tfrdmMofONFMGtYrl0phVcJMY
V7sGiwUvsclk3okySX5Omzw5cGs74RepHD1+xmpIuF7os347YX1umOCoMT3n8fyp7ir7C4Ot9k1Z
HPvfg60Wl+Ruq4FW0+EQ/ZstfibXqIFEOnWdwamSd4QEzq8A8WL7BP3DAh8U5KzBJ5R6CxXCXLjF
/ZiekuaikoiO5dCo1dG+i+tz/4P48JQOeCi3jWNT6qO8RwXB0wJrzk550+VvqCBrB8d6zwzlMgEI
4W9tWxKujRK9uZgjpgRRVHpzXIKdg74r++vxBu9dHzYXvBfgAjLMzUOI+GHSOVqGk0rjNHSVPqk/
yy0iJh15imcF4afH9nbXxaALFCIwCOEe1+5CQRBgttF08GJ7Lr4BNpD/scz+COqyuyoBgwJ6zJqs
jc9vq0KXZwtymXxZxnd6CRdSEy21V0tW97GvnKMbsfO2wVQAnauocICa2Lj60qbllyQTDJpjL2Wu
nlEoPhsZDHFutEALdykVoOy+LsfR18f7uWuZOjWpLIItprNZqVnZxuy0pA02OkCfoZ4MP/M0cDDV
yuSdzxUqhqU0H3iAPadPm8d4oUwQLEzrrzjUxN9SEtpeNThaDy5qad+iWhq+Z5yPGVwl0aT6HMda
9CtqYidy6bwiOP545XteiIIXVS3w46DdNntuLkphwXRveTp8evDAyUX43SlSBzqaqT6asdk7UFSw
QACBm4UYcHNNWsfoCdoIp7oMbk29b1GxNOf6TREGPxdy+YP93fuq0GxTaCZUogO1eVRtbRxVero2
E68aHLFacy16+b0xF/XFmYGwN319hP7cN0maCzkA8f92jCXIJDOnNkiY1AcO8KaxZja+s2cPcVvn
R2km+XMYDsYBHnnPKuwRhCJiW7mr64MEGXeSzpFMh0mjMpFLkeRLRtjdwiVxfpqVYbpzrYW3xyfn
TrSB4BhE5v+3un2/TQTEE84PlLBzK39wlMg4I0Bk/7BHToBLpDOidN2rlDDM2Hwnqb2O8nLZeko3
LiaUq2AezUjW/mYb27/CpJzfFdnSfXj8K/c8JZoskL8Ab6PhsNkaTUJ1pwQS70VTuFzQHwjetf1U
XR5b2btFMLmJyywosbaJUDMHcmrQA0IMbALPnBe6K6em7NmF0p1fb4rZDIqLtNcoiYs79lvYoMgN
dPcdganiDJA/Sol+Sih+XeYWzonHpvb2DoSCADoi/EtVZW0qN4nJitQG4Jtk6bkeAgnZcWs4OLx7
eyfGsV5wmxSixK/4bUFTkmZDqokCWz7/Ao8XXtVm+UEZ+AhRsmeI9JEgSiUCYp55baiSlb5C9YG5
lobGWZBqI9pEknFLQ4L7xzu3Y8qBLRvmHwoBvCmbj1QsaZINAulYMiL63GroXaug0F0GF4/47/dM
Ab4GAAQyQmCA1qvS1VRnoh0o/RLHgV9UfXouqar/XKbpqBS6Z4oMHEicoA2E03VtKhzgEID8X0Q5
VnWhph/5VgzHQZsoR8XevUaMkCgk/RLQFWhx1raCQkNNOqksL0vk8qKoteTGGcRW8xD2p4LyMvrn
yBi39oAu8xwyXJcr9SVapuIUyf18awsjOwDU7LxeQgKH1oOIhoCwrX/SbBdZg/gPfcs+rr2Ospk3
lgrxsWrCNjv2qv/4EN15dfgQoc4RQFWKSYQJa3vWiBOQCdz9oFLK89hRz1T6MDvjgTRPNjv53IGn
fu3JfTEKrRdCAgB1tzEfIJBAQUEx9eO2bMMTHH8DTMWzFb1DiEP6+XiFdwdqbWzbs6htdWFAqk/9
yOn059gePmZRZl6lhc79H1giz4ASjW93N3Jlm3OqEGqkfjilpZfpYehLwzDTRK+PChY7VHuC3u9/
tjZHdzSqmM55k/opTMFPEFfXyIKHMOiFsuIjnt53bm2VvTvbvfS1MgK0t+NpyvuTpafRkxyl9Udp
KgKvHPvqjTHO1sGTeHeOxa5TZ6AezPW6k2gYLJKGISpTf4CB9ar1U+hXnW3+RU2+/ErIFBwkYffk
IMIgoFZgEsjVkvSuD3Ip0z5ZaLv5i1FbPzu6m7/gT6pUGDg6YpOxdcZv3RAVH4rRsD/and5Pt0iJ
dUZmnHSpTmjWyP8Zh8Vk4DwGnnfwzO3thyM44EWGyBTGJgwfEbOd7GjIfaPvxr/mZZSkk1HW0pfI
GNLnwpyPNM12LrZAsonxEtpZcHis96MfO80arSn3k1BJcjdXYDyMGUz62ln8WwclROMmyAx8fHwH
xLlb5dyQ7AI6pLhDxYV/NucyjRRlnPMu91MO3cmWaNnXk1qeZRQq3xsK1QBq9ZmraKh7loCdD47B
zmXHPOnqi0vTtxweKnOGeZuXua/acHjQKGi8vKpSN9PmV/ewWamAyUCMQ0AGF+J6gw1IeGwmASGT
tErJa+FjeU661jrldEOOGPb2PqaIgRkYonxHOWNty6L8XfYmCnhO0EwnAj77nGZMJS4gsD0lDqZL
3yNY9/hT7uwluE5IJeG1AWiyNTowJxEMVRz6UdNHn2CbCYB8LPNzn8rN+bEpcfo3p0aQP1BloHNH
AL2JLwj/QmVU8ZdBj9YsvOzjKcjU3jOiqDtlEPN68dTltyVK/329YaR3RHWM6j9AxfXGclzHAH8u
eaoZTt8yJWq/FZEaXTR4TE4tiYXPxHn6t+BrPSL93fEIwJ1FgornYtxs800zXUcLOkZQS9Kd6H1W
h/8ubWye+zksqANAxP54pXvmsAYvAd6AZspmi2ki1GM9KhJgOdn6GCqz9TVdlupLHRXZp7pX54Nn
d9ceXUr6hdBQ886vd7Y2pVpTpRH9uKmjGcVjdWL2J/HDYYl8Oe8O4qb7E0QOzvWQMSa+p/g5vwX4
CXLFQ9QPkb8EQDss2G2eurRFHz6T+4sUNR8QzfuriIyj4ZSXUcv10RXJP104FHFBs22zsjhPi6lH
wsJHak6FZCrL+/fpVJnTxUom52OpTUXhTyG3+mTbUly6aSvN6XOFWNTNSiAtdVtDjp5VmcYHlS+5
+Scrg6b0Ri1xvliJ5ryPyrwuTkqlUpiemk7mrapRHEPCzZA/MOeNRI9OVRX2rVCTf6C8gDp7Hc22
r1ROqB/EODuBBw0SulW4WIOZQmez0cxDGyq6R9Bod3JGgj3BgmjplZdNU+KlthK4SIwPNAJFD2FO
NP4bNBtSqWdwm9SKK6X5/BxJionQgNQcuKz73ihxMyADkmRBF3g3i6HGYxKPNMT9aolUtzMWlYoz
go4pdChXWYnME2XIhIqpo7uMCfaXuYceFcpI5wBLfu88CeBFqwO9dwGs3Rz/XFNmPYqN0DeV0XJD
VG3crlzCWz5U+sGbt/dJ6D3TsGPJL9Ke67PfOl3WKQPd13YekBpH1Lt5GjTSmhh6DuXkqF3yt9FO
Mpp4dTj8V5IitMpHpKUYe1jsJ7NGTDlbcvk8MOZyTiCnOioA3r9fTM9D+Q90ASiWskWBDEuVRVUX
RjQN+SxlrabeEKEFURmV7atSyIBQ3hzFArtGxa4QJtPL3FL7hKRtsj4GghSPuwnLexVdU9mJ01Oz
FOm30eYyLrl19OWF3944BJgC/md249dNSR6RHExxcsmY3OCNRc+yKebzY3e+tziaOsR2jK5QPN88
XCEimFHV4nbiEgyosaQIy6QQK9oBmrWMAhr+NOEpHhvdcbKcZpRPICWgo7a9+5JcWmAkUW4IdCmF
GDesroCh6GEZ0vIpjMb40k5i/Ndyjgam71N1LjbOBuCJxZwV2LP1Gc/oFTVUN3CzWRhmpxB90fcW
mnPvTIBaH/mgw1erGaMnaBjzWxeH+a3MjPLNmBbSEwyj6lsry+N/H2/HPRkNP4peNXVmUjFYNTdv
qkLDUmUaik+t6ZVvZEPmI+xVnyTHGs8LuoY+qUTzEe0u6FLRVPR7NAS8gx8hjGzPG3QKMu6O9w/s
6npneriTBvQ62Rmzbs8DefU5p+rxxmmi0V0kdXou53GS3VDJkp+ylenxZQkiHTLsSjt4hPecHq0p
ogtNYDu3bXTF6eqhbhrUHsJ4vioDdIhTaH+xQ+PIodynGew8J+KFQV/0d9eLJq/LtVmeOP5palzn
Rte/DxSULpUzt9Opk9LAlftRuyroHL8DFqZ+f7zrezcBUlEyACAjQGC2Xx4QhhllhBuZDkv9XAe/
tKLoP08NPF5WFSU3yjUJ+nJN+J/Hhve8C70cQBIAjxQSnfXC8yWaLPiWMCxXTLkXTCNZAUoNj62I
7dueKerMYARFoR+A09qKWaKkwkQX8iHI2/qxXKD3CCuXB8dv+FlrYI95bG/Pm9EYE1TDnBxe8LU9
aWmh9s6xt8Tq/GQsjaydiqAW0LLakf4mosnOcp5kr65rcoFNdpGZK2a1YQRb23X6jOnQOEx822Lw
MGL69705xv/q8/QH8amglGQ2gC4R9jb+OkLX2Q4J8H2dNqdnL4FJRDpbvTcwkfEVJVTLVSXF/tjm
zeFl2buWpgiPKUfTnt6+vrFlF6nlpLFvJwXTV3mpeWXZRFeasfqBB9g7OL+b2jx+RZFN+dDnsS/Z
iI9BTG24A3wbLt2K7twiB3NwUPcODp1UsGHUmkwgFusPSElFiqGvif0gI+ptFttmXE/VXBQMOzdO
5eCEEPR4eXxa9/YTU8CECDQ5OhuPW6dpoTdTEftlW89eCC3wuS0t2EIHHoDHpvauO+4UX4qOGcDL
zX6mfZI6BEmx31FQO6shqjlzxXl9bOUFMri97wwZUQUWTEdk/ettTLu07nS20LfyuHmaIVw5U/1A
4EW2Jvk5GaX5u8IU2ydLL5UzJEHdv5Ae9Re1resr4d7oaUOl+amkoJ3CsLyna/noW6pRHbjdvc9N
v8OmAQlegFnJ9e+0ljyFJ7JO/MWWY1cCoeVVjaH5jcyMxFCVy0VnMOavx7uz4+thBIeUlpHyF3Ln
tdF5skpEnRt0NVWneKOq/Veti5cvcyAtLnO2jitJGWKaTVG8frXMo+pw0UCnT99l88hIbZeFHT0K
X42LHkTCtHj61MRXR5N0D5bk+CIv5XRgdC+FogiD/jNzGUAytjDjFqGKMGrIJqrBbi5RlealN1iR
5VJepRdIH+28KHr+Vum64Z2kFKiHLnWcIKgUIHz9eOt3bhq/BVAxVVO815bhotdVBl9CVEcLM5TP
ulLO760h1DxNm4fXguOIauHSoIQsxG4hul5/ZYJKlYHsFH3zLlX0pzzoou9abuaKX9M/uRRhlP5K
NKu9RKHj5O5YNM3t8WJ3DjcD9mSNSJZBdL1tHU56FXYT1JE+RF36c9GX2m1kUveWhcq/NZDfE/LD
R3H1jr8WoAxeJBI0le7yetXKRPqbRCmdGCVOL4ylDjcp7u0brLrZta/S6MvjNe7cJUjo6YwyQULD
d1stsSY9qAqm8Ygp5sYPkYc6m52C8L3X/rev9OlNuqB5/tjmziHideACUfYS9ImbNTqGNCVTQauE
53d2a300Lpkmx2eIMI7YZO+2k9yErq/gMKClyIlab2dND20hS0/9RNJ7kYG1F7nERxa6BEF7INcH
S7u/rBxVniKFUJCZZEyuDSpypkJFnEpeBNDlRq3B8APJyYoTU4/1X3GqzLdOtlAANQflnPZF+TlK
nNyv8zw7uD87SxeoUgjJaPvQTNw4q3Y0asDgVKFKealcXW4LMHDnkWZU2byaG1msWgVJxPNLqWeL
uEtqvFYoYytn5AOtVjOfQZ9UlXY06XH3/L4YErg+DIGEE4v+raqYdwQwGTgx9ESG8BYog3MqYL44
qlrd3XwyGA6o4BlEGYwi4tpMKSsdg05B4Omw61+Mhtl/JiXUN9EQBj/qlp6slJr9zSnm8AsDwd17
PZr077nMgG7YDuoZuc3ppAdR6WtO3tqntJTKX8PQ9B8f36S72yt+J0EPSCd6OyB517/TCSf4cyt4
/oN4Kp5USYt+tmkYfLUD2Uncymia7+VcVL7d5Eckt3eXWJgGmQqhJQCEO2oeND8gC2TuBQxtYl2b
yTH/njpFv/VS2n5+vMqdj446DlGX4FShY7f56NPipCaq2aI3Cnd/nyWTGyhS/OX1VuhPvXTnoGPe
4vKWYCz1Qks4WoFa3pyl7p/7qjrqtO+shbYRLRUGNLgyW8zhUiF1IVlz4El9bV5nEp5Tjwrawcu1
Z+WlDiVwL7zVm7czdlBxs60x8Jyws69FLSVneyiag9xi5wiQPpH7QvZJW3lLeij1oP8NsxNdqDi/
hVGnnRmIyLymYjDh8ce5M0WBG6iQ6FvAtUSmvT7oZmXZOfUemNHmqfEnXYu/ptGCNm+Sh/99bOru
TjHzQRUPx0k6QRNsY2rU0Q7LwhFTsIM/NYoe+E1qRNcMl++2URu9nwPjcz52qvfY8M4akSAgiSGV
F6Ilm7eq6fq0SxIgAGNqx++zIgg9HawoI0OqfXA+dky9MBSR2XOziN/X21mhBG2HreJAiD0h2tYN
JQ6O7Pe5d8AU+o/XtbOhdOxo5QldY0a6N0/iYJp1aESQc0iUExuX1dnPSGvOf0WBzsPYF2311QjT
xO11sD4HrnxvpZSEoGRiQIuQY7PSNNCKKleYomw6+wf8qdFTHuYzdxzYyeuXCeYQcCTPLrOc4pf8
9jQtLRO34JIcL0mkaDi13TSD1uuiT3q/hLZLR8B+drIo/4rnHL49tr23SrJuYB0U+khPNrZjY5AS
ZzAdD04/DVy9hdb5QAFFUxigemzqzrUwPAoSkTIN3I5UCrT1MgPET7UiCxyvHR3lNjHF/dRLZnuQ
9NwFL6JpJOh3qCLoIOw3VuxJCUdEcW2P0L54MrM5dKdZK96hGqhew6k1X39MBFEYc7Ew0wqxkfWq
DDACDfVs28vjCnXZiIlm+t/S1Skr4+Cd2VsaQs/Q/tP3vVdrTMdYZcKXmSqJEvJTVyb5NaH9mp1K
hqFUTx+7Ib4+/mb3xXq2U0BH+WwvQ83Oenl9QQFMCFV6VkfJ5zTMZY5q2cz8XDmHw6dcMUcov7N5
8YAM2zCb5JL9JDmL4qZaqvuOCVGb2crx349/186x5Wcxf8N9YRZ562oHqdFa1m/zsEfFD5knfvAA
Ss+X2Z6WA/zTji26+mLfqVML+bb1FhilHsyIrTj04EqQBKXGgEORB9BA5ur58bJ2HN4Lhg95H5RN
4fBZm4JXKWBUMAAO3g75OUqU/oQPR3fSlovUjbRm+GL3y8fWyctfjy3vLpJvCXoCRBO+dm25L9UE
dSgWuSQdzELQfF8rhGdPRjrUR2dKbNiqREWdTQCs+XSkyPZ2lSkyXoYamlzRHKHPmkmCGyDl8ZKO
unIz7To/z9oQXGodQVDVSuZz6OjF698xge0VqAa8EkN76/UmixLRxlRsbxZjTaBu9aesUBTPKAb9
wMXufVQAMdTiyOwgWth81HB0xm6OwfgD0JbeD/Fsuz395DPjaSF0KIlBNqtC95mk6RHF7d5XRbQR
1XhoJYD+bJwTbTagYw5sxKGh/9OqzXgO7US70ERZXk2XAYEWkQ90rcAJ7mRTa92p57DvmH+snOy0
mKACh7T8aY6jc/Dl7r3gy3gRIRYGgSRugoIRqN1E/8v2khxIYBlbhWeMqIzYNADedPNwFBHf7yH2
YKYSroaAZ4tD680SXs8Gfs1ubH81gZ1dhz5+P9X6dHntFSTXpaMAS5RokN6RbtWFZXQMX3hMRtRX
GYp/rwB74UFn8+UPLJF7vVx2mW7C+vAXswPjvtCsgiAGOtvYMK5hnU+iEib9waJ4s0jyLcJFCFLX
phKlSmYlg0YlGrL5Rj8hBbA45G7cOUcER3sfioBUPAi8x5Rt1qbg1xeV0ApJmEDoMLR65E6S1AJP
UE3/1Rso5G/ARRIM0+oSV/63iK2SINpTFrjvjTppJKZWAuVaqUUJRbsx/nxsa+e8izIbTXqxLEBm
a1u9HBhtahcIjA3WN8Cw0/shVHoPJvCCZrV2NNl7H6WB9wS9x7pEW3KrVZBZRVgXCsI6jtUGfiIP
jp9YWfzaEhOOn0/1/7BW3KzNopxc12aKzvBexTQk8zYQKJKmvQVJV14B+NGveLyLd3WZjcHNkUeW
HRFbnXOoMPl0UnTJ9ily0N9nYP9dPGqx3zrFEb+DCI7WDx1ul+eFKSuGn+4GYpivD6bGYS97GKTf
dktrn6O6Gy72FMVn5qYLt14m6xY2gX7Li3k8uOZ7Jwd2D+oehBLwOohP/dspJQ3s6ySGc0ualsAd
lTRzl7iefbizqxsoXuW1QCn2WHAu0OGgGgKmfW1vLAdunoZenCY3xnd0FCTzJNWjgRKLzfjc4w8q
Tsjd3jpIsCDWyBXcFg5rEtRUa1ncxBSYKzFIdcuscr7KgZK8tqXNurgTkLSB2uUrbmLgwurHnDlW
0xvluPPzTFNFwNB6cmY3n3jAkw9Qr//BM0eziIICG8mw+XawogthHrETbkg9t+mV7lDnOVPY8kej
uEOXyK/OY1gkZgS5FmWZbZSr2/hmNWaRVZdX58G0atCMunRz5DI6yHfvS91iQ2kmck6INAEkrw9K
odXZ2MQcFFOXnMkd4MPXXbgEgyedFv479Hulv6eGwEgGknGdFLh8m9jULzMZxsGy99wdh4efI4iU
CCrWP4V8NQ2GASacqpoTurLGSFky0g6ioz3vA9nWC5KRtMXZ3AypbiOQEAwAZRbju2RU6SmNtOGk
Iwx9NgNj8Nq4sA6e3vu4U6AW6QDTnCH43OIU9NpuAO4jJKpVU36xZmly61gyrwhjSm43Vygjp8Nw
c6L0yNnuOR6RScCFAryMgvt6U+ect7GpNRRN7Sh/nyZFrZM5xlZ8ops8dCeTKuPRsNnehyRFpbtL
rgYSZOPsSn2W8lZDOg00UXie1VJyrayTD2hN9rzO71Y271YA1jpuIND3wkLu/Vlqh1M3OIsbh/Cj
v97BUZ4HLECgAS3R5pKMWi3bS4w0mdxpjbfIweJGIRD+ojL+QIqNViVvPV+MgT2Id9cfbJmyLLQ7
5g8bM+plKGlS1T6FRmB/SyElSm5zomf/qp1RfJpB9MWnIbXG73ZfvhojwXej84XyBxoIYCI3cVVc
aH3J1AkHR2MGYug6622U28vXxzu79yyLCFGMsFNJ3ypBjd0ELraiJJzP1lic2iiW/qnbXPvpNKMU
nXih1c4nOeviU9znyFo01vAnbzNhwcs8tMCab4oKmZo6TjmnyI86XeUFRuEMp3DI0voEU8OQnCSp
CI9I43bXDZ8HeZNQrNxGrVk/5XWKeohnx/nsDnnZuSV0+rfKSEMvVAr5VFUd/L7ZUJxbcOFHXER7
bgEAGphhmZcU0Mf6lBUlE+BmjHBkUcrmh1aGxWos8eih3gd+B6fX0azNnk8QkGEmxCArIBFeG5Sk
IeibmFFhEt7EnZGBfzc6U/Dj8XHa8wnQBcD4BL8SD8nG8ySKXamTycs5y07oDSEUyaMmWSc0zYy/
H5va20Fql4yVwmgILnOTTWkqAuzDiEs30YPzU0NSb2YlJSe7Ap3fTHzVx/Z2CK0EM97/DG4erlKN
lJnJMvQC6nR4Vuza8bRez10TIi+3rmvH1Z0xPctKa7+tq5RZ/gbyHycIXbPr44MHbe/X8FJTkhfT
38DxN27KbKSmcEzSrqUu6h8JULLWFX5thk7SyH8tEDrjH+um1WDNKxT5HIOXfzPrUzC7eSlxyual
a1+NbKHVA7KH+F5Eo3dzvmWr9Yo9EeXPjC36U0dVtGvMN/NUWv7jz7FznleWthfImiI5LrGkqL1K
H1AMifb5kTj7znkWLKukDYLVljLd+tYoc7DIWgbPY0DH/Ko3M5FnFoxeG8K3+nhBu6aAMzKyDecC
mcPa1IJW3dD3MJ+i1wiZOg2XpyqtPy/aVB1EYDs3B2dPlwVcDi5hy00wJk5ZJgbFAavRu3M2qtZZ
Bul2tezU8uvWll6fM4DFoduBo6PLvhU76xPJrjRAB95oMVETt5bmznjYa5TYdeRmZZr+bcnRdFTw
210mY2E21RbmCbZlXGV0OmsqiKyNcrHfgG2ZP1CpIM9Ml+Cd3hjLwZXceVLoPArxAYo7gnRv/QGT
em4KXfCQTkqCIIZULr7R9D1zEopduHbR5xe0QOy3Y6y3buRk/YF9ceM3WeDKvjhgv6W4ydB3FcyN
bLOuL1c1lVKmClT7qWuA7WtAxl1jTtqD1HMnsKbDK1QkGRUA5bFxQ7YcToU+wd4EO0l1jSxLRTRS
BlqAiMu1Ddrspilp5ZZ98eoRf1wN8REhPb6GF2BjeU6qJrPwK+hJIFfLUxSctD7W3Hgum3dL2tdX
SFJfDboSRolE6W8JYpwtLQ5YjpRXmkuaoKgKNmfM4eMpkjd40iPthz1/QLVEAHQoW5DZrz9nDk24
NsyUQBczZLx4MDp3LuP0PNBQ8B+7nr2b8rupjZebB1MZDGjkvXJhK+06Ua6ZEiinudK1k6FEzvmx
vfvRLoEIYLNe3lMKoptgxAojqaWMR6YJ+eGvejT1JydtHN+qAwozwRLllSs3rdW7yTwMz6UmMdQF
gRMhRTI2vsT4ydc0NAxXAwjylzZK1rfHv3DndeFYQQYL9Au8xBagbGtznUGwYHlhHvRvmjz47xjW
R7rlO19YzMwT3YuCFOX79RfW5bqvrBHmrGBkeC8wpOQypRWUEbF1NIl8zyNAzfR3W5u6TTx3k9MH
8JGZc2OVrtMsluJJZjH/V42c9ldcAzt6L8WKlftA6tPv5tjqoVuFdSohU2RK9glWnTC5lrbs+Aie
y93BGbzfDDhugRiK5gwP4NaRWI4kQ/vkaJ6ZoPQ9Ss3kZk2s+NFY2weJ6/3HhXmJF4nJphclYfFT
fnOU8Numsp2gqzhIhvpuhIjpVjnLkV7XvWek4EzUIBJ/Eals4lPJZKxrEdqRYE7Nsz1V5S0yIUx0
02yamWmsis/tOGqeSvPhtZAiUimyOeIvurRCA2q9QGi3NYWmHmriHS9Bq6gVGlf1dJ67LPUeX5T7
z4Yp+ma4fzI4sou1qaAOMi3JasOznCJ7myIQf12CPndJYb78gSVSCjGZBI3OtpAiwNgTxCp8NUfq
QE73AYtqpXM1KdpBKHb/kvL/Jz4SMlMkh9u5AbkswZBn6DpaQZFcwzb+jj/rztaUJIT86XjK6vRo
WOHeB69sbkUh6lmCsKPF5mhIgyfbYewOplq78VRF5zgd/0Cu5Pc1bo/nMjndSFsHe7VUkiKo9TmM
NOf6+KPtropXWhTdSTytTc60NNaiFYEBrn8YU3d0aiA8aDGcynSZrpJph5c/sEfZhhE24loG6dbH
cRwzeIVrU/ciOck+KRB7nW11Mk7olFPiM9qjMsLuJadDSX2GGBMo9tpe3+VZTMmUk5La+Vk22vgU
RPP0ngHyyFXV3maKwswuaqMlt9evVExpEnPRDLvLTMymTcY2QUvVSLvw2iQTiajUFWBI5eamzNL3
x+buh0JZJBVgkntcNPyS4kv/5jTrZlBr8OWI8kUSRK+9XT4FRreckmTMPM3Iej9ow/rE2y39tLXi
m5KiA/z4N+wdJvCrYkbGhMRZ3fhtXtK5UayJBLxCtaU2Eis8xTYsZC3sErdZSo8QP3vOjTK4iDOp
Q0OBt16zNDvjgEA6rGdqWD8PvfVNCXoFSdn8SEB8d2lsMOUgwS20TZHqLDb7uqKYkepd5ctDXJwG
a7Lc3pyyZ4SLDgkIxeuzThawRqIOcT2uGzKL9dI0tZnGEo4U/LZAaYWDfM5zM6Gs2qvQ9sbVLZNC
01XmUX9vOkl7yZ1IdlE9c17/USnqAsig5MoLsu1dUUkAf1IjphbBHVScSK4UP106BpG0QLsGUaP+
9fgU7XxU0jOqU4yHqIDTNy6pbzWeEr6lJ43V+CtJyvA2wtnpg5SrD5qAL2DTzS7T59eFcgMTTyDH
1rucjlkAeg1ySUkpB9MtO0jQGC5q2tKtUcH6mKSS+W+stk3vSRAfBqeF2AtHVaZRfdLzZBpOswGT
s0c7aqRC2FrVJ1hrFcuPliaXT63hLB+qsUbJplrU4e8E9fLitISZjvy2GkUNLFA6vf9cl4p3SRZH
2QnOsE49hSFdmH9KZYJwgxGh3jxH0O+GJxBOA2z7dd18zEBZ/1KnJpNOXWVyNOa5kGvC8q6cXS2q
04/jUvbVBfekyX5StarkmU3e/JUkqvHfpS7NT1EeOp+aKGgWrzWk7sj5ithivbtCaIdZZcHEIqb3
17ur9xLyvsoAHs9Wq28MLdKQjI3uUhtGcXEsYh3mprNTlwQKxJXy58fn6P7KCuvwSFJd0Bhv2DiH
no5yUKWCZa8NwreTU3XtCZ5o461pDK3ujpFq//MHFgF0grEgI2R8Y73edObcKBY1Y1FRfmei1+bO
plZ+UKyo8lt4yA5ye7F/2/0lZ6ABCopJxEJre6VjROo8kOx2wGduRRB1Z0h/KJRTcD0VsjKfE6uP
D7b1/npSKULGhaoNaQAY7rVRJ4WoQ4Of0DNbM/vSMTmNSsBg/B9n57UjuQ2s4ScSoBxupVb3xJ3N
u/aNsMGmcqLy059PC5xzpjXCCGMYsC92YTYpslis+sM7aJzGQV3K3JsfIHW62dg8YNF6PZRIe2Wc
I5SgYw5jUCRK9CRS1Tp4beztk5UO8b+jrL/i2cWZzMaUlHaCMjOUhbu8KfuHRpnzAHw8rz6jKo/k
LHY/GxUZgL/WGn02ny1ytVwZbR7XjdJ1YaUvQB0WZbrkaYsxa7motylAv4OUefezrW6pq1Ulnc7N
3iwFXJDBYJayi+VH20wiv4+G4v3YHLrI7w1F7QB0HWkeOezmYVU1fScVi2Pfm+V0E5tDE/Qytf3I
i45eintLCRAdOTQuDHrV60959u3QAG6kl2DFKDog6eVgeQEN7egLZa/60V6A+9puoZ3ffswNjrgO
Ah5i+5adlSyN0S46S5lg9TleJi1pPwy5q4fRTKQPGqME4ff6kLvzJEenRIDgh+Ouf/5snmqisaau
cE5Nk+i3AGyH02RUzUMx9/mNQVfjEo1zdfkvg5LGUQEhe962wMzOTWyRu/ZJ5mr12Obd372HQm6s
KB0E5GwMslI7muj2MIJR4+XPrU8mu0rcbfYOD+AK1YBsCSO1ik62VeUnMyrjoC7q6aQX3nLw/tm+
D/6Mh7wsnt3ET/oi1wtb1qSVoxtzG8/uGjSzZa5xDZ+bOyw+3UvbZc4D3PXxrPW2/v319d2bK9Pl
ZsR4mo20iaRO3celbk9LmDnx307aTh8SWgu+bY63hRGP/7w+2vYyXmdK1w+oIbEbysFmZWuy5yXG
8iUUkW6Cim/iuxSVjfJcy7n5pCp1F2ra3P4V9VP+0E2uftB53J0tJk5UZumVUyC4XmlQVcoAUnwJ
kRF3gwUS7MmMu/zR7jXNV+ZeHIT1Fw+iPxNGtxCoP0BV0FfXA9I8paVq1ixvV2o3y7g4v1cS7UX2
nRaaczGelFrRw35u1HtTy+JPMc6SBxnBNhTyGzg3Dn1Jng2wOTefeMJqRPKRl9DMvfk04nMWpFaa
B6m6HPGPdodiJ629XShAW3WIZRSFXuFkEipV278z43yV0FXrL8NUHjVudobiqHBAVyYsy7v++bNo
tHSJ5UpJ+wTzUfujbRQAwscsvS8y5WD9tnGP9QN5z8OdewRw4haRO4hUwV9NqKGe2/FJUZcRVa1Z
+SlI6d+hc0X5uzQLebB19uaHagmY0tViiyvzen4GPgV6CZQjdKTqQMLsFzyAmvi2SQ8hXXu7FMs/
zgWQWVuDJ3I9VtQxRUtTlnDwVkv2yZlm5LtT+6bAnuSv2cjyX4s7O5dptPSzttSuekaPUG3eeMGw
0LTOacZR2UWFYRsH6aT0btspathl41dFmMqdVdILTEdkneJlqP25q9sjjMXOOpO7rlLvKw+QB+b1
3JfCynUVmYGQp4l20YRQzrE1JR8R4tQP7rKd6MdDCsEycHw4NGzhpUVJMVGzMy2MtMYNXf51cTUe
8Umhz2Fj1P2D58Ygl+KiPFX9lL2x4IugBVgj4JGQRdY4sF5Dz06MoVSTqlilFrb0ik5oS8TfhZe3
p1ksy+3rcf5lnIXcBTgfcOTa59/WRJKiTVt6MlpY4BcYOEXe3/WqvtzVtVf7Riu7L6+P93JltVUI
ACAt8WA1kr+emuu2VGopPIVTwv5t1XG4kU73y0DF4b2lVfW9Ij3tDsEA1V/qMj+9PvrLLYTgF0g6
0mmDHGWbL+hRHonKHMaQSlt5ryTxv4XViPeOzNTz6yPtzJPMBKC5yWOKbvkmBZvtfnZnl1A0tfoU
Vp6efaSYOd8Kq8RvT5+6O6VMZWDlSxTqVjUcbOA/kgrPH3tsIWIt3VR2KrjXrcYDPOqolOUwh3am
x8bFsKNM9Xnt6RSBbBE/SgoRXgDsQf/l1pocz6txTxokapd+yHk2FU8tQMcUwWnh1UhUJvRHV1/4
+b4jT6/ve7voUJqn34n0h0yjFtVGF23QDBXgS16MZX3w6V7GdixEgAWB8Vr1XrbtfyyrGk10Fac/
cquL2bpTqNVqdTJTaia5qBOiYVTZ/7z+GfdHXZnP8BKJupsbuWjzBewVoyZFr1/yWY6XDjHOd95c
dv+2E0/2YijjH68PanIGtt8OCNuqNAw+mqLE9RmxR6X0ZqrToQPF5DGf3CKcpGsf7NCdswByDKAg
cnw88rb5Ot6bRmt3DsJpsjYvNT2vgPCrBIsoioNv9zJtpuYK5Jue0qobsSWudopZlFWcqWFhu1lg
JOl8sSMX3SbFtZ+8yFNQIGzvMdhow9dXcm+OpHJ0IleGI4SW65UcAaTMNUy5sEQYOqAJnl8g/4KP
0SxxUBzcuZo5aCtPndvpD7X7eqyaYA5ZISX5aFXzFr/Lv+bFa8+YKienTJ2am67t2rvJwLHaL9u0
CfBCPeq67kRzDjuPdvyqeQ5to2viCDtX7VYNLRXmQNoX/V0ypPGvFo/Gh6qxC+sgEdgZEOrRKjyy
dhGAVl1P2nCF0I0G4kVvTtVnUaVYUAhR3iaAalBXU4/kqF+ex1XKjN40ScuKSFt/z7ObMbMpw2GN
pYaunYh7pXR7/CWNyPQxA5fnKp+Gz7N09M+vb6OX+5c8Z8UdOaQ8oO7WYP9sVLPvDDeuWNa+9+xg
rWfB61HKr3HZlvemNH+W1UpdtpT3r4/7cvsSBkCzsrh8Tl6d1+Ma8IzxP+Sy1C3pfUD/DAelLMnv
kiyPD47ozsJeDbVJYsXUQ9KsiAaemxYYTKZRkAvLfVJbA5HQqK4DzVi6g+Rjd34mvUSaMbyot0hh
C8R1o/V8zRFS7BdckYvfjsVVwmPCeHO04ylJkFNJ0GngbxPnsbaF1UnUnHpSPvwmHP1x0ZEhqB3l
P4xEkorK8ep9RUPm+qOhapvYsl2w4ozaPCisaDhX0jV9J1GUj6/vj5dJBmUl2PKUBLgtoLJfD1Un
JiR1U2UoR+9v6xH+geKgY6RN+MTV7Ed/LsEZDSO6ztn8dtCqzik0ac1S8EHxBGTT9fhjXywVRAEZ
qpCvbrtysr/Gg2P41Ii0d5XelQH5kbwp87r/wP25nFFchbQIMCRHbJpGx0E0ermfsEQn+K4pLSFp
W/dC0MduIzuXYVEvo69FhfqFngi2NHiQ3Ly+9C/Pyx9xUV6zBAUUBDaYDHuwo8JYojIUllEGipC/
R7v27tKhkyFkseVjPHdHMjkvw9A6JknlmrquqeX1cqu5g4sKeR0Shsig5J6i+7YyzI9zlvenZAVV
NfOsnz0ZH6FzX4Z5hHMMCHeooRHnt9nkYsyGKEq9CqscxwEF/PZtnbrTBdyx5i/kSB/evrq8LIn1
pAzs7fVDPwu4OYIvFbpJVWgV6BEnqpMFXr8gDbpI8yZts28UMY88sfbmSC0RWQ248+zpzWbOyNfJ
9tQqjKpJD1KniU+mjDlM6pQGonLtNwc/Ts6z8TZxYrQc6VWJViHcUye+3tTOYzV35UV1a/sgN9md
GgW9VfyZat5WWrVCfaqO5FiFZmPCxZgs6gdlrWBYLGbfq723F++YGi8fZ5UeBs6/2ahzJfOY5wlL
OWXixs2Q+cqq8jK1ph22vXXEJ9w7FyCjgD/T17fgMV7vFqnbrZG5fRk6IrG+Ciy5As9JklMFjOIk
G815tGSbBRki4OHr+3SdyHWmTm8OmBuTQfWFjsL1yKbQnDyf9DKMo1g+jfowP9jFkB0UmF4olRBn
nw2DrMP1MKKujVmbrTLEdyvBoKATJ8Ns5YMbiQ+RW5p3sVPEYYxpcdCKCueFlNU2x358AJLTkdZP
5hsx539+EYFvJVPTbtuCo9F+45ndOWU4LPMYNmnXoPRQFIHaLOPZjbujcuXeDuZU4v61UhGgjl2v
gOxtUKGdWobI0WS/CxW+eK3roxoMsywyeP7V8Ov1T7s/Io8WbvC1prgJQXYqO5x/+LRTI02/pawX
9knUnDVzFlhDu0cArp27S6NBtFbUsLPhhXs9w242Mei1zTLUCgRvwJO7gbt45W1dN93Bftq7u9YK
6SqphRT7ttQNuW2SY+Ly8dzYezTHeTw1ZeV8imQxPpRzScybe9wpX1/QnVEhidKNAoCDGuJWjmmg
DulMg1GF7TjI22oalBsIkyLAGUAN+srWgpQm1cGg6wHcHFCwuAAKAIas/JrNvknrEUSxlzchEj8D
xQwzekQW+bc1GNj2uPl4FyPXQrXSzu7lqOUHp2RnypBvqTVxm/CY32r0yTZul9GQDbJJUR+UDT7e
oycWP9OH7LNjt1qQmPoRZu4FBZlbGtkB6j8GKw3bcLNzEdYYB9uo3RNOvrUd0kRZytOiLcbPLM+j
W3MYgJMUCOg+FRPGvvdz2kXfvUok9WmyFeXg7tmuwfpr1uiIuh8eneB9rvf1bNLlLOBcrnC9+TaV
fR8uLdrIVtfKcMwKw4+qQjn47Nu4zKDk3oBLKdqABNjqjXhmplhxlkcnJ47Lr6x2+W1ulyMu8HZz
/RkF3BHMgZWMvF1oLQII5QxFdDKKwnjQFQW1S3hbp8gQ/e3UDvlZGrXld0lS3ZeDexCgtgFjHZ1i
5loeNqGabyuMRt/jyDOZ3kn09fIQl8adIdThrh6pU79+cvdGIiOibgP+YDWov/6EU4vPk+eg8oPg
oDf6FmIuJTZBTfOXWi7lAYpjdzAgOLyyqX9jy3c9mDaVRdzQSwdfYTSdLzVDPmhtjRIeUnzZ19dn
trdPCAz/N9jm/i4MbyhN3CRPU5Q5f2cy1m+6ebYv/2GU9TVIX4S0aNtNULw2osaGJS45nhNOsT3e
COQSD3Lm3YUDB0JjmnuC/X+9cEuHIjToSeBTWu5e9LouTkMXeU9TZPx+fT7bfGvdecA1EA5ErY3W
wWYkdR48FNpMoFJcEwGoXerEBrbvJ0+bnPuh6ZJ7zQTQ4aIv9saI+mfoP+ANgExg/jfxfKybInHR
jDkpVZTcTXqm+arW2LdTHyMsKJTlTunM8eC+3KYCDErOhQ87uOAVyLGGuGevkc5OTciJyDIJu+5x
gB/Vyu/wSvpSDHPzpPCQ/fj6Au8NSOK8dhMplwL5vx4Qt/koyQaHWdbR7JdNNuHSbegYMtjKnYbY
/un18Xa2DqOBmYKaToK1JRhgflmnPTJxp77TqhunLoa72Jzts0OufrCWu0NxL1HzIaBAd72eWhkN
uVeOrnuK9LE8aUatQkp31HOD5PbbwxZVULSKebsilr71dpOTTe6fD8wqbcbbuBY/azy6P2iS58/r
67dzERCRvLUSAG+CbPF6Ul2qDLCqWudktbn9YR709hsN4CTwYqv8zOPVvi+jRQSqGCMq3aM4GH5v
TcHIcwuBX8RXcnMeo3ZucFMGllrMBgmqbJvL6Gby1M7Tz9cnun6d5+nUehJW1Z/VuRJp2y0qJE6B
100TkcwrkElskDj5C7Z/fXAF7G1/cGecOTwzVijR9XLWdmmjLk186dqx+NS1RXyL+8kQmLJ3bzR6
dcHrs9r7fEA+194EkG1s0K7H67VeOotFpzWXQ38pXLv+3Vi1/p6YpqN7qdrZ2R7c8jEC1P2tdKQ4
ko1+8cBb15Xkn53Dewry4+YeMnGDsynvIpO6gF84j1YbQbns8584Pqtf2rguzyninxKovG3iHLTI
Do7Hkv3ISzUf/CHX7b/yqVIOou3exkKs2EXpZH0FbdlAC2YwfVcu3mlOF+OMrf3su0Zk3Ta0AA8O
6943h7MIHYEWv/oC3WQKKFxLmyLS2EhFPWXGYiICDRxP93vTTj4RvKIDoa7dVQfbBKB57fMD37j+
7sRYw5VkIKe8ipMvaaPHN07V1k9NLOwLb6Fq9I1JX4kmtSp8oVrll6SD6oIR97BQ0FX76qdqFdER
YGYnZeaQUcYEDMTNs61n5MLMkV1Dj8BtNW4a1uxmkQwYz5Q2a63D+A6rtuH8+inY+djEZdcFSIdW
H9fP9WpYdZOJjNb9SZ2d9X1gYJFmWUMQOzh6vD7UzoFbRXK5cRCVZe+vP+XZhTpawNK1gvttTJQ2
hKMAyMGWtZ9Afgk6Hga3dl5+MZsiD4vFng622k4QY4utfjzgqtFJ2VznlZBdansx0stKZ9y0EGB4
HY7xQVDZW04Eq1fXO25wXgLXczQHezGijDt1GpMfmEmIL4I9eJ+5TnKwmjtHh4bIiglcHR3Iza5H
apIG0nbBGg7A1LAtjD2/UjCJdxYJRIW31s3rX29vPIh0XN48LtH93FSj1KQpWtWQHsCUrkBSKvss
oQpdlKYqgzrPj5rHf3p6m0sHcsva84NyRqlpMz85iIyP1HpIzcUlBi7J4OeRIwNeCfXdLJXlJm7c
wW8tjLjaCR3bZEmdx9xg23qjtG96y/7t8JeDyaZsXtj9eLAge5+a8IGmIKGEAv1mQfQeEKrn5d6p
hbDOdhb2h7YgfIFSjMLX1/5oqM1a5KsuSFEy1JirxW0Kv5c2nZG8t/TurZrW67mEmABuGdoF6vKb
OykWcZ+O8LZOjZmJi7mUNHkXpTo4JjubiVcRal7wx6H+b834BNjeri5QzsZlnO9aLq7wHSG1sDbH
JLA61/739RXcebysiIc/JTakc7bToteKq5mN9nmkZMsXzaUC5UT5o1In8/eZgt+7xSk6v1ySt4qu
/1lPQHvUTFc9+62Tsl7ZODONFjOdSQ3dWC98j/b5O1M0xcG9vTtHmCxrYQJ93C3TI55niqW6iHgA
KvY/MC3q0o8VtWyCqWrS77Ml9HdOC++vbbojavrODl2Zk8BXVlFB8MrX0Qj1AxCuvBBJ8FP9azMD
KppdK8p9rxqOGEN7YxH3VrgFsrwAd6/HqlIHScYJhfd+zRPMXHPvUBq+cxd4TK/vmt2R1jcvsXzl
mm1m5ZW45GhNHZ1KI2mUkAIPOMQenak+iDN0jw+uqBdgEjYLMAeQz6BKEUTawvJUK6kBb8bYHsBY
FL5XWN1ftp72gQOowleWDO5OZH9dOtxr4qQwgxLDgIOjuXNP8htWkAWKYmvp/Xp140iYML6wXii1
KPmWtGbzpeFtcTDVnWSHej4NYcp1f0h816NwcSqVXWGZQiVNxeKwiCsodFbqN712MhXpWGdFk9pb
zXn+LPBqf0QVg2xza8mn6sjUJKYaURhF0NNSR/tzOorPb9411GL+f5A1+D3Lc7w0LpdaY5DJkBHc
Eg4bhrjiXDTjeBDW/vQHNrckY1GmA+tEzXn7sM5kQQnLgEUfKaL41Ttd/kXXs+WHptjJHQKJ2aXB
rPur0DGKAUlXx3fSbavC71Qw7wPi90fbZyeykyKsPFu6chSJNttHGWOjNxctOvWxll4o107nQs6V
j8ZAA+PeOLiE9/YRlIz1ZbpizLdvFXdeNU8QeDr1uogj3JNhFfUre3sZbu3O6H5XKtZvD8Al5FGG
shMcwOmRsq9Cqmvou/7MNBQmD0LGapJjAkJCgOBT0uRNjh/SfGSjvTfW2hNH9nLFmGyrfIri5KhM
dPh05Wjny6xRKf0mTThqRXL7+u7d+4DPh9p8QC3NM7eSI65dZWHgnI5dcpqrw9lT+i4oe1c7GG9/
akRxLo01z9tkzJrXRGNjzcoJRXm64pFm/taT6VsBl+br6zPbe/mtxS46A7SEQIusP+XZwcQoUHSa
zhebUSr8sRgSTy6UfX/0jYbMGXT1T+tjHendPPbtQji3WmqYfqMCgpXUj6g+mkcmaXurveJaqcBh
IUjYv/5JBpLCuaOoykniS53fQC4cnhqtcv0S+b9bmLm99fZ3AxRt8Du8M3nlb0Edc143ijpXygna
UkcO7cifZj/UYamP7xbPKv5DMKTGoWkg68GAbh9ESR/RPNCwkprdEnePojf82IXmkkT2W5kCa3B3
Vr/sVSGao7mu9bPPSzKeZWNKLIQXHn3J0+o7YBXvrDniv+xZ8JZwIOi4kWmtd+izkTQvXYrEnpTT
MunO93mIP7RmO56SRD/iJ6//p218B0kBZn7VuGQhr0eanTirZ4/9kU26PNWZKf0I8euD23hvF64y
qRR7afEjKXA9Co/LhdoOZ9BEWOjiynH8BhQw8pW8y84igxP9+kncnRWVYJgWAIQR1L0eT1Gdfh5T
Szn1yIydJidtPvRzSj/h9WFehhaeMCAHVjNHl02xSd/6QSZqHWObaUxT9zVvAQsHdTlXH5AphQH9
5sHIl+A7cRnxn+2emDoUSvKiEuGiFUtgdJ53US3gx4OjjweJ/vq7rzcFCqB4qQDEINsmbFwvX42i
AEQLkzM1Gs5PSGriUtajislv2/S3MZjdG62xestfEMae/MiYx4NT/fID8gtWjgxUlT/ktetfUGqK
jqSTp5w0bBfup67Q7tLSOXIierkt11FWFu0f/e7tg8YYulmmbS7A2YgiwOau+AsbR5yA46ZWPmPv
mrzVd4y3E6UU6vkAQMB/bEtU0VwPbYwUCwWo1rtNlyRC7qExw5jOxkHmsrM5r4baRCvETsbKM1sR
tlWWn1Ai7h7QUct9fGSij69vzd2vtRp8s2lWH9VN+cAo2EVp3ItQ4kl9Ia+Wn1ThFf9hQvST1li/
lkO29KW+Mb3SjvHmrZLWu8RW/UsUYjgnjvn2B+BqBr22VNes9wXAoo2MxTCmSEDLTATGopH6sayT
ovJXLdG3xxCuFBB7VCnY7tuHreYmqTp1OKTitNvj+YGlgpzlFNqg+N7cJEM8hc6+yjeC8f9CsL4w
6nhWungtghQ3izBQBNKaHC2p6Qggs7cjuJAB8P4pTWytWVV7FFrV67g3y7gLOzlpl0qTzfn1fbe3
xVcFg7W6DwJ7yzY1s1rGS9bEpKmxBrPfRihdb8RtWqdH0fflO+APZJTiMtXllRB6HZCGyYvHtsOL
fOFg4cDUJI+zkqpPVGN/WG6qYmYWu+Hr09tZRIgf1LFo/8G92AJzAZxnmt1YMaAWc3zS9UK8y6r8
SMZszQA3wR4akgmMEx9OgFubYN8DzK/LyUvCJKpF0LfGELgpJjDJpLKwwizPeiqSMHM1ccBH3Am/
VyNvwobIikYMsZOEdltV5zkvh/ellP2tTIxGoNA8dQcD7iwoiquwLbjYaEdv1dP6UZe6LojvhZRG
wDf1bs0KS6nXP9tOlYVHAPpMdP1oAL0wC0qrVWMimzBqVxcljDxXBpPTRmFFXAkQLtRvh7IUlw46
6B2fXfcjPRsP9s7O0YDtzSvEQXSMWsTm1eOl8CDxMs9CPdWmk+KM+iVOapenVpp+f32+e0PxziYq
c1MDZ9h8xlzSfoMVkKKWULS39aQk/qLVSyBb1z3IgXb2Ki9+yo84CqAfvj3wq2l7UcV5FtI4ne8c
LtEPRdVgkMS9+tSoaxFiqPKEjK+oooOxd3YrY6OTwD+4TW9rZ9MMUFhYRRYqQrFDY0GJuMcSKgBO
JEK9HtODbbS7rM/G2+SwjYiK2TIZD4awDGrXLgNPaeUdUgVHSKKd4EaFZ4WhAGgksdOvg5s7Fp2a
G14a6kus/pgKmvyTmacfmsR0Sj+nGvg377zi8h/2DU9FWoOEnhes2Z5Db6XobIQNNtN3/L38BsCI
duc1ffzmGoC1CpitAkV0nHlQXU9QleuzpMGaXBmT8RSJNPmqK+AZ2iTrD4baW0uyIGjWFMhBZ60x
6NnTDb/vvJV0HMPGjREqc5vqLNSxCeN5MJ+WMasuWKeZBwnY3t58Pui6l54N6nSWoRi5zblw1PrO
7oQW1Ele3VV9n9y5Q/dWxRtO+ornWV9WMObh6l+PZ8bo92RRnIfQ8x6LYuR27+MLiZh9iSAlB5Xn
HmUUe1PkkqKlvt4ZLySk0wTvjMIZk7CnCZngRI5BU59NQgRDElu3+nIobLV3AMG7rRgKmF0ATa8n
aWeqUDx9TsKulH04tIM4K57TPXS99fvtJwHU5UoGhG+ACMH1SEpa6V4aqUkIRd66SaMsRtDT6IO6
UuR/OHQmYEtyGJ5WL0CXeh+1g9PIJEQ2VzzRvEm4DL3xfpm0I2r1utOvEwsekeBIScxW+NLWe6BP
sT3uFicNwaKV78G6Vg9md6i1/XJfrBRKSnvg6NBI3ha40JLAsmJlTBko2UL878+220NBr9SfzZwY
B0H55cuYfrFlYslBtQ5A/SZSSm0pUT0Eeu2UcXFpltw910J5snpsSJx4GG+kh7usyLvoYpjTUf/m
ZWwBDEYNHjXAlVW5LcbHuGr12gQVLIsiC9G+Yb6zU6v6ZHp950d2I4Oy8toPb92cmEkjE8zqAq3j
6F1vTjdLHbN0PRnyDhqCLJPy4qmr3nNHPfHNQyEKxkuI8QD0b4W0psiLB8UbihAWZD/4aS/0yBey
9CofI4n0AEL+MpnAA/sP+WNl/xOqryfGl4ozu83ycI6M5m4EcXZa0HEIMFD1ToVbfsTf2bgFp3Iw
y71xOXhgHVbWm7adZdlC3ux0QChGWjiPg5qnT6ONIYAYlU9xoXeXMtWZ8MxWfvvyujQbdZIntIi2
3JNEbZeBhc1D0bbjrTZky63u9D1mKG6uqgfv2t1ZulRXYE7a1ATWk/TsSuqMqbF7OeWhhChBy6LX
pO/IQj1n/fyUNWPzufRwX8kG+wj29jJury61a4GFKhl31Oa7mtOgU4PH16C2VFLBYjAuTbRMt2Wr
FgdbaHcomBgwQYhfHJHNJFOLKJrIdUVdg3YYZDFLacWT2dTlwTHcW0+wRTB/QUgCM9hGnib18lTB
PypzIUfCG5SXWhkq6MC69nUwav0y61Z/ggMyHOzXlxGWksEaYRmYovQLF3K1aRtI/uzX3kzOFgqv
51qVWrAUsfU5FXL68vo25Xm75mPXVwf5xcq4pTxH2rYV1pfDKEUWTRi/4ek3GD7PHE34Y51Rv5Kx
ViACF6lRHETGNBP02H3NqRdNZWLcmOonUYMn9Y1umWy/SZXmk0YTJPJT22gqfxxHvCOV3m6CEuJr
7TtQhf5tFe77sMTx6CeGZThxON7kFXhXe00DJ1biWVqbToddd19GYzAnMzeZXsQJ4yTxNN7Alihr
UtnO+Hs1pSpupyFyx5Pe9UYX9DV/k4EytGvjAlC0P8I9uFGtrJBBUQv9e9KkVXvqunh+h2iFSC+9
6JW/rdnybkpbZNLXpiRxL4JZh3qfQMnrqqnXA0pgsQzNNZadvDTrTpgbSdiXstVAKLGEt6qs8MVC
RQWxxdFDj8WXKJI9yiQ2/01Rc22DcsiMf5xxTrPbDIurp8gUo3lCR9n47BRpqqLjnI7ASgYelf5c
USe9RLObf8JVFVXFyVGT+8VNNPNs6or8BYyLinhbdfldn3aOeV83bhL7o24PYxCZynCb1UajvXNn
W33IbHU07uNpEV95a+gfhiUZf5RFkv9lVqL9AVgHp4M8ydu/haJlxV2qjmaCyW8sf2sKeIVATfLy
fs4jria15fEiNXV+4iJr60vfN/H7FGsC4Ruy8H7WlrDUk9kldh4M+lA0p6EpFctXUVmI/aVolV8N
6jm9P0Syne89JBLqQOlV/X1ngFi6WZYoH4Mu7w3YFoZT0l0YU1fxU3MCTCiRH3J9xHi6r1oso3fa
nHXJqa3N7nsaK9PkO17miMCdhvyx4eXzj56SXPq8yTGrHACN/lT7Mc6CppoM41HvRZr5ucjR/bTc
rOxPWlIV34bWi6pg9pbhrpUCGzS0DarbwSht01fUCMJvvfTll3wQaHPJJpq6IOoaVl/kjT7CaVDN
f0xR5iCR4CS3vt2L6ZsdNVl0VzDYL/g4RhH0hQC+xOubJAM8z/xzRCHqPkMx/TcKXVyOmRctdVgU
KWWLDOGlLDScvnovvdXES6peq/rC7uKzpITu+Glk9f8meQobbDLcS+IsvXLWm37+1ur5kgRKVdqS
NYlUEl6XehN7NepYVpHMgVPnnsAuWEkkyvPD1J7GotCS86wOZYVisZ4VASpp1fxhSdLFDvNR2AWK
YThbt/nYu76pKOoPMeIG77eAdm9HQ8c0XK+z7NfQuBA95qJQ7mNjED9RjJk/WZ1OlcZMp1kLMm0S
j6m2tFUAEzgxf6lO4jnv5wwBwZr6/nAynaZDEsCspyZYosVIy9OUVWjxz2C8Y74Gj/igFAPAmr63
PeMR+I33l1krmvkh0idj8tHCAnvodw6q9LeDrtVIACqyiTu/gifxo+g7hGVqx86rfwEiARhuEcxQ
w5onw1Ovpb1aBmYeR2bAj4iqO45Jm/mJ08XjO5Fpy+CDtRkfnDZTTBSaK4CLuGa06XdLMQFvTFqJ
m3DrKHjqFkU74EKkSokPZBTJz8OE5/ClakWf+aOyWP94Hfo2iPrZsYE2tDa/FxmZVdCMkjPm1uOE
tLuTF9kPD3Ja6yNH3adPna6WbutXjRNrH9G/z2Sw2Gnype41xfMdMxky34u1AVQFADAkkWplBHYp
p646xSI3DN+d4zm5eMbQf7MsEdm+kwlXv5kWhcSQVMKJz8WcTNp5WVDpOM9aVekPM3pAxT/Doono
k9HGpfxYRZX5CStPbgffM7vqnZXqevLYudnY/86VSCvvEUrw4neOOuX6dzTxdPfRHepMO1GzUz7W
dVznBARh2sBFpZEjdD7pRmDOWZpcJHj+f7zc6R+sMRu7m0YjxpydGgnaG8+pGl4LSR83qF011RKU
dmrzERMFbzXNHruLEUdjerayGiWLInL6f2ItUY3H0S6Kf6ekshZIO3bXBFlU9vpjWiz5l1qZuujO
FnCmT7WduB+dXtWKkD5d0Z5ns6/+tXunxFB4iecvStcPedCTYyYPcZdM9tnj9xinpfeW9NactVrc
qXY0uP6U876+yRVzGe97VxAsFyHlvWEmlvgxd0OVntrSWpaTmed17audzPSPsknK+D0bsMnwsTNy
pQkKle32ziHBqy5a4kBeyedc9y52ndmNn7am0cF/Fo7zEcyEojaBLfsiOld4gkynASFZzE9l1s7y
nDOZ5rGWApytmvRZV2B0KUfDT9revqcAOxQ33rA43jlRi5mwqUw9tF+Fu8M5V9FQTx9QsOA4YkPa
suX0OXLDqreML7mjju0D8uWLyHzdSNVvtmiW9FTCDfgf6s6rt3IkTdN/pVD3rKE3i+m+IA+PkXdp
bwgppaK3EbS/fh+qsmdSJ9V5tgZYYPemGwWlFGQwzGdeA3ajo7QxXMSRYtZ1oLRQIybUjzyxEIu4
mMDGl4PTlAocBqvKvRhZv2Ty/tSMIlGvi0JTh08asKkkzChWtNuJjqZlbO2qXNxtJ+yxWJGvdhei
8YrmhpAx+I3tWGpz+1mNkQpV/AS0U75VhDIgDlaZbYtOWJbljW8C5s9eCElRUeVWXsantpRju6Pf
PcoHW1G7ORBNm3A4Ij6q4alW1UDw6ZZw3xlz77HztdrYZm7vtOAAu67BbQNygu8sTqN+9VI3q/1V
/spAo3xqPHoCsNYDDrFq9GMXu7lgwvSUyrYROU6AKTAHgVRLy058DDrnC/g1KP7MQ5Rc94NdzmHS
R3NyqeNwc94pRZFt0q4tLjQvV8p9iUK4GmhjET8NGZ8SwTg3LwDug7kKsrTVKcIUsvd80KXWvEn6
0pvOpMlZ5y96PC7BVEzi84xCyvVQzXhKlp0zUR+q0l71IwhSBwpFxDQiTyVn3KDLT/2QeP0Ge6nY
8LNJztfVIC2F1FbV42DmZP3ojV02+QWE32u00zl5SyBYCR4l3B2+1Zt6epOqksRJM/Oy9HPcT70N
/IvewuACSTwMmk19KbdSqHW+kcpY6ds5KkjVcyTJsMMw5vlaTFVnBBp1utSvE3sykUyXxRBQzLZ1
33OWIb6KUy9OnkWZyakI6iHKAcRT7quQ+XMJf7UMlU58V3M32xb1ZM0XjWsJ8yDMxND3RTWl094S
mmx2sRJJnh30SjlnwdSVnv3QNrPd5oQ/vYg8EPAtdhlmhrvqZWvWhbxsssTEW75uRk/3dWeZTdef
TUdpPxOcts0np23q6DoqvZijUCVqH2NfsfK+OR9GfaFGjiih3GuRXV7FoEPijdPmiTyYkSvibsP/
KOlLl8SlRUm9EsNmQJyyCm0l7/gumUtkxhlRmn7cafTo0RjBPGX2SjQBpwF7kT1ln0bZoOBvjHdu
WZsfNP7asluAf8T+pOhdhwYlTmFbXZ3dx9pemsjXJNDQfStinA5IVFMRGh4R5PloeuLBWaifhqYz
OlB0sJRV/cwSsrtuZKGo/mQ7r1QAaasbh2Mi8bGIEhxICtrfl1Oa4C2acMMMGw167jdrctyZ/ZJZ
X/UxstpgdLz4VhCa6BuAHibuNiriZnPh0dcjmUnkBgfjSPdlYYoL1l+k7Iwsawzfo/NxLQyvnnaV
4GeVm5j5JgeQ/eeSZzqRH+3Yu9Qcpy9yLLMrbFioP6c5VPyLvClMwpA2ii2/9kZM7xJVxDBVaiiv
epREw8bWciMJETkzi9BrBu2DlSdO50tzBjQH57y6LjpdjIFSmJ0XwI7Qb9oJ+oQPhcuTOxKu9nlZ
ZHnu9a7b7KeyGD+jN+hdZrOXmWw5APIEERq/YQ/eLPZp7mxFbijXlVn1HMSJ4R76TF+ec3uOqlt3
7PVrFqbRkTPEyj2QCich0ivyM1AV0QezxLzaz0kk7qI8ionr065+4LXM5NxJqphhUle9nnBn0YJK
0eSlZ0+qTtwrlujcrifzk1AJZnmVaJb7bLZrYyMMC+0PcrXlE74b7HjD62dzRzbQRYfWbQvHn0q+
z8ato+46m9vO8fM+ixFhqAdmW+XKO1dHXf2GxSMWdT3Kjk899+MzTr3IS87Syy4n2XLBuf2gpn4x
cPyEbAXzM/ZYsgpbuPZuUErLKoLUq5GOn9Os37HpMNHR4lQ7uJ2+1qhGN0Y/zShE4E3qoAeGKXsn
zI1Bu6hT1igC3lZU+pkolhKjeCyq9t5omhXSBWhwh5aeKWekFUq8tevO/pb0ClCiZejKlOx5KXJu
mIY7BF8mT1wRkPWVH1fC0raCGwDKPt2NFznXU+GXA7pKu9zKoye59BkpQ58ZVggZwMbBSQcNZZDV
4slnJnrne7Niz/eGcDXCTrQ7zhtd8LcB1qkFKspVZQf5Mhe7pY/Gya/S0sju+kFTv9mqavdB3Dp5
tS2tif3fkThn7F900bgXbO1b7nhFvKktjVg/j+xKI323AGzUVEWnQNqFXmwy0/VyX4OZN/rJVA0m
zqJAmSlNDZRw7XEE/a5UJhyfVtiPQ9J3U8i1HQsu5qLVfM1TW3OHMaqeh9XUZkPYWw5yKmktvUCp
hmjmA1NHwbbUrjNf6zrcnWwzTrqrKSqaqxK5LekjveO5lxF57h45VO2DGrVuTUgdZ1xosWfcZwkA
ampJ6bJJivVuMHrdmANV7Yju9YyqWzD1Tn9nmwIuaW8nZnZWtXQTfVjl5kNaR2LeiybzPsHgNS6y
Lta+YiVRFRdLipgZd+rSNsFYFcatXhm2cgO5YryM6LxqAfFBxOm6cBsHBc/4Zw1dh6NkXpzLsaSX
5RMtynSPY3zPhBpKWvsAp3XJ5FoWEYTVLZdW7Cws09QkbqkW+ysQgyE+K0SVk1mOrjkEUPlw24pM
q3QQi5ow3cr6guOez1l4V301zg4lHEos18jB5r0Pm0Hc6jgtLttRneqXMp9moArW5BFTTZFFHUgz
k6c1PeGK49wet+S+wzPXgZaiolil6NYVPdNiuxN1LLwMH5dpHpdNGdeKd27KRL8GZa3dV42nJoE6
zP2BhmlCCuU42W1lWjOuizraaL6NDrXpu1YhPmiRmT7pRme+yEl6tL6jpt5NEmGzgPyNvNwkFbbY
iF57lrvLIHxZuch0pnVTRJzq2vzCDeDWQd7141ejVpViu6R9TE9Z5u51uQpWgtlKym+1OcpxZ5ae
aKmALBgF2LGt30VLrWv+NC1G6Ss1OvI7oyAi8Jnj7rFRs6r3s8HuJ+Jbt35w3FpeWHASar9iPVx3
dVZ8StF3e6GLFu2JZ5URxdsyIwIR9iEfl/bzOMBF8ZvWo2JQGW1JTd6IIhrDjlRKwsZcO5NpkaY7
o9Rj6mkdZXRfKdHc2E1ezGGXjd2YHmy30JuA3hOAnVqqpAVqWetXsnRmzIOSfuh4cVPbMxlVvBEo
ozQhf2O4txPV4p4tjTbfxDOGVAFoHJwfJ0s2T1RfHJWIJJ7usizWKyyKkDzys9FWny0657GfNFnh
QooqxFMJ6cz2m64jgZ26yb3quq5GoLbMtHtDUbWvXpGMWjBJ9Itl4dW3Gat+CaxWH87cOW6cQJHE
IQe7R+GYeqRVn3UzAI9AyaS5TWaSXB/1SWf0Ec2Y7NBpolEhTBvLmSOqST8jC1R8aj0t/ywylTqE
UOfY2sqoGZ/EkNR3XlZTsxSeLfSN1Vj2lyiZCiaNytNC39pQn1IzNy5G8HZjoCaK1viLM8TP7lgT
FfYkUpwGuqV+sY2koagVDzEB1NiKCxtNOIUjJl8udJi4STB4CwAw3avtB01k5kHPh/xzZaH0FSbC
sl8IumZ2o9La98JB7hCzvDn/RNk2e6K/jaUiy9M6jJEj06DE0BhIe+syplR74GQ2tk9PswYU3M+Z
6NGPKDhaW9yJDLjHrdLE+7ipNYKoqCSTa8Q07MpIL1O0AC1z3zpprPpFXs9USNxeSTZ51K0Hdxpb
15rnVvhX1Wr7PCWteBlgnwm/cl1MZAxJRT5w0D+6A5rlFMEs2vabKjh8Q9aV9TJzOn8EkF5/5CV0
ahGpRSARKRi3+0XRNl3gpLkyhouhYUVVOxkubnknVJeSBC1BVAq9QdlMnt2uN6LbHJph5CwYeyO9
9pQYhUzbkeMmH9CjDAYz5S4ayYteNEksBXO0sg5lXza6T7ZjfpQZwKArC6/pNuDelg77Q5ZIssuk
mJCERffyoKbppN942lLMa1ioN2y/xp03InM5NI0+Sd19R42XLK+2zeTMoOZYhDLJirPGmIZhW6qK
9HytVK0p6O2h0QIXpw36I5NpD74ubOcRdEdHVWQaNEJPHgpdegrLOy/TRiOI6Z6gz5Mn+XmB3Zpy
aWQk/ZvB8JTGd6VBGceLLbPdOVkapajZDxaVcJG19+Og5ummr81J+rL0+uSain38Verof6/2mPJG
lpYGam+p7Osx7a3xzlHG7FlzRZRuk7VF58dc9rjqaLXZBZgQaDsp+qwI23ko7zvpkKb2k0MgHxFx
dMB/bO+yRkcbaVIpx6vMsKtllwL1IugpLKclZDaWfK3MmeA5tXS506tRSfYY3GVfiILI/pSocRAk
96jIQBotxX3NyoyxcJ6cfgO2sD7ElVF/SV0z+tDP+NivJeS6OZe0IdxgzEhpgkUI68ypMOplcyC5
EHqIb9f+RIRW7qbScqdDTcXuC3ZL5m2sOHkatFz3Hq/bWMVGHTWt980+6i9jY3JQ06IIo/momVBp
q1xL+TKRX1wniyUf2mHOb+q8Ibqq3Np9YEPxdRo3ys9rtmfrx4nmZmcOlasuUD1FSQ+5HhsggWVT
remFPfAvleFcxDRZZq1ACkJIk9TQJJfIBoK52SK53ETu4JiBqaZNFtCMsnZmPOg4RlU5U1k6dn3L
8VHd1FUxZVwLULU2XWRpoWG1lUFVa9AuieIGthLULcu96BoqphcdqRtKgwiF7a1xGm6tUZu/9lUv
0zNPCs7BuBf6XpR24gTj6qUS1MQpL0pradcxZw1buIllHmLz7X1AyEejKptWzpc5aoEyYu/usr6i
3rnPRVdl2FrYsACrsmscP/XQw/HdvHGSXTrqmDaqLmUB9lcb43FfFWVEdQ8UnW90Ti/WaNbdFTXF
vM2UtdpDb5rFByvuzauxVWfUijoEuYM6nuYd4AeT5pNRZQ0ao4qHXpeXJJ872UdiD/I2xmbHK77N
KfQLn8oSeRGsBbXcul1UqKFdedZ1JXv2RjKxq7jqzYkyJyGnuhnspLl16IX9aertkPkUaIhM4piq
q+/GJeiHYomtp8KU2ROueGApF4R49vEyVflFXfUknDp3ABmM7UxnFOLQ7+5iR6S3lbFS6ayqq29O
9PRWCMvbjh5NRBOHBncV00Rh7G2nVBQSoQF8NkInreYrIxI4HIuWs0VgmRVpOVUuYv1DWYhxkyiD
t+3L7JSE8iuL7aeHAAu5QtVXebUVX/FDT5rFJ+H0JyW47qg7X/hm970n8+d0aRzMgjsEd0je0cL2
hyXhPiCcbeONhczeGQoq1E9/PSk/A2TocgKgwqSMQh2c3LePI3WtRpQsLkI41dUFmXX90BpleoLM
8V77Fo1d+sawR1CPPpr5Za7cPB7UMixISfeQZeutQ/dkW6DquhF2dUr25ue3AvMDvd8ElkNsetwu
TmhTtkXsVaFXDJ7fJ814TiNCPdF5fwcKs9JRESYAhoO54vrWP3zKupSL4U5lGaqiY2OWTvFSL233
YEU2RNQF57pOaaf7X3+wd9r9kCNVdAdXcgAEubeDUjEeLe78MlySdgxqdzL2pldHW5HU1QkY4Tsg
YlbFCmDwmEjW6tELKlieLQDoq9BM4o9Nj5WHMQwioNlWXWC3Ee11tBG3ta2Jj7WxdEFR6PUp8dD3
PuWPz3C0QGNdiY1RerzvhGIQMU5RXSRKof99aAPLBBjhSrlHPeUYnekUQz5TpwgZy/aJzfvYtyLq
1TDK3KexNvDEyfIh+QKc5pRc8nu7gxle1fp04FzH1tOQIhdOpawKq8LsL1KnBTk5Jx0N/qb5KhWa
vL9eQu+OhwCPDVoaYRV9hXn8sG7TBla+UnQozqrFDG+sGQNLye3tYNEw61cJ3l+P9w4nlXVkgYAA
o+JwAK/f+IcBYWjG6mwVVRiVRZMc8pmRglq3oot5tLOrbjLknRC00CosbICLj3R2jVxZbF83BzeM
69I6K/tc//Tr53p3aaFphoSnzic/Fr/rK8tIIzQlsSBx8q9KD6VcQdb5BAjp3dn20KdGBISvfMza
SPpJkpjpAMoWUvPUU+rrXBvpHpN8XXbc9SdO9HdOJQxdkMhA3onq7TEUPrHb1hpMpwzxPfUOet/L
La1Hi5IWcC81ktbt4nT18HffcvU4QNMPpR40k/VjWdKlzTWTiLIKRdVEL46V5R8hRc1XjTYth9mE
kHviNX8+nF5HhFON6RGYwGPWaFJOXpfOSR06lswQ3bXMB7PwqGu5ixOkILuDqmB5z7OkpqY5wBxK
oCm/XkE/AaLWZ0Ad1QY4CyTyGGgtu8HMsllhYauOjYjV4p7l5sp0GyiGV0Wsb121cYOsLfq/KyTH
yPAymHIUHniAo6OZHpcho0ygQ15Zxb6XbRwCFhF+M49YQA3mKTnwn1bxOh6ELRewIBL9x7ETV+gc
z0tZ43OjZ49uYjfFxiHPeVrQVm0DfelOOWj8tI4ZcaUer3YoQKuORRam0qNDB7Yb8sqA7Zxji+sh
AUCSYrlzDvzAuQLj4Jw4En66XddBAb87KDIBsT223E77oXKRgKvDvnEr3/MAeNe0FYEIFsnu12vn
vfdb729GWTEFPwusK7pJC6MKU0ctWt9SyrbcIximub6xqHJHOJ9/rZjcE+O+bow3ESjviHwwwHk2
KoJBR0unHgB7ANlpQsWZ7DtJWkmpysP0u8hGA3m0JRcfKcFlYdvE7iegyBX5+BDFFwkYKfoFMXlJ
AubiPkm0yPULnW7k/+A0gSC1Ror0CMAav70wiECNIbGjOnSbutor1LhCIMfNzvWoyCTLPJzQy3tv
dVPmBGZPPLdew2/Hi71WlubYNmEztnNgzUWynZTEPEetLkf1KjvFi/1Z0oRvwG24kt2gMfB/bwds
7JI2ZSmbMBpNqsFqtNwQXMTTeYRZ1bUz24sMuzkxvkhFd64ytSpvbH3oIr/sFvO2EeDd//6Uo6+5
Cq2tvExs894+0SCbdhBV1IQY3ZahJ+pmX1ZNEiLJpW2dDlf1Xy//d3aahtIHMFnMf+AyHQVcVBKM
KlZHpjwz0n3fySfs4+PQRStn++uRfrrmiefgxZNsIekGC+BopMWMEjPWaWVkRMvCt9XUeEEj75S0
4c93wbp+0N/ik5prWvB2AuMRjxZ8vtowrxp1CwoHIWnDUM7cpUBs0QI80UaOcSBlOKVL9XNOuTJE
wOVykkAKQ+zz7dCYnHu1MxptaNAmBBibA5hwnGQjUbIawqY37YOsxz7UE+IcU3rNddL24jMp0ilv
3Z+/Kh6IBlh2GNLspGM97XwkmVQBSyAQ4EZ7ZRqnPz14OjejtNr+xIp9dyziSlJ56vBoO759axqC
LtBnxnJbVfrFZCC1q2WLP81zHv56Cb03FFRKD79wDTTwschC1VtNvbhWG6qzMDcsseKgR+WHXGuz
E6fzz4t13YUQLlEQRqry+CSig2GAP/X4lFO+CJ9aLbDNRMRNfGL2fmKRsGbQj9eYPpy/uA/ezh4c
sXY0+wzXqG7+KKT9oEB82CxDJkLLxmJ6MSgKOSswoFXa/MSWfG8+eUUKIKvcDxfu28FFrRpzsvCW
o1J4247GyQGkULrPu6U5MdTP1+yrAyDm5Ox/Yomj94RwoDVAV7rQySy5LRrVvpmJnELViRpAL+RI
Fh0wrztR8Xh3Tzq0s/417hEDQLfbRM1xUgXkxZkwtkN8KEtX2+pVI7YVppMbJA67Q5l5HjeM7O4X
s3MfK6ypT53s7ywpEj3qRMSEVEOOyTOLGSMznFcddh+9HQAOV8/KrHFOzPO7oxAZOgg123zVo3ku
8UBIyM27cKbNuaHcJM9rqs5f//ZGXIUXVqYoA1FzebtwEB7VuBrbLsSaq9o1w5yEGNTp/lRp04kL
yuZPvQ2TYBOTzJC4wRvjdH07VK16Wuy2OhukLbrQLXDhjIVRvUzsJ9+dEMc5sSPfHRCTZ5V30GEY
H93AiTtp4DScjrYPGo4j9OlNkVvPdPnhAFh5ceKDvbMH13MTQTGUY0AdH12L+C1Tki9rgTxCbARp
ZakUPAo1mJnUE5vhvbVhoQwJv5CLAeHft1MJmtmZCg9TjI7ZvtVGjL42np2Bl//16nhvHAJqUgYE
W2xkxN6Ogw0cSjh5jO6udN3Qi+QVdIxT9mjvzdurGSY7yoFWeDRITy6rxNHYhWPioRFL9X4bO/2y
sSq2+K/f552zC8eu1ZqCqIIXOzpDhGbJoZsaTN9MYzX2RV8PuwWwJ0M6XSI2bwd9OvxtPUiWPWwi
aougVslP1vf/oViDo1bSDNkoQq0kafe6sdtDFrlpZqGduOvemUnOAdVdzZIJnY71ATS4hNXoVSJE
u2I4G3Oc7DJ4wsHotqcSindWBtOIKJCzihFAI3z7UrQpq5zQSYQFni03tIUc35TWcGKdv7ODudE0
YhIqpp51bOFpV+h9TYvJOi/yOcySOtlXtMQwV6AbRxn5fxABQQOlFIyULIfhMe9Uj4ShYVQhwzqB
4t2rk+O3FRFgVibTX/WG//g2/a/4pb756+AT//xP/vtb3cw0qBN59J//vG5eqnvZvbzIy8fmP9df
/a9/+vYX/3mZfutqUf8pj//Vm1/i738ff/MoH9/8R1jJVM63/Us3370Iao6vA/Ck67/8P/3hby+v
f+Vhbl7+8fu3uq/k+tfitK5+//6jw/M/fnfZVf/x45///rOrx5Jf2z529ctvB1E8Vs/i+NdeHoX8
x++K/Ye+VoCIDnHBRQdmPbnHl9cfOX9woK87mJ9Cdlwrn1XdyeQfv9v6HzQNoPyDZ+K0Itj7/TdR
968/0viRieIl0SYa4iRJv//r+d58qP/+cL9VfXlTp5UU//j9VWH/vy8y8kUkiKnzUkRfaa1cLG/X
PoZpqGX1lRmkTipuReZpBySZHoAHpyHqmNGBOhrOjnIyvhpaP5xjzdUFWdbLszQD6KYh+oZvX3KP
6XeyazQB0AMGOv38/HbSnJsfZvf70//4tG836l8PixktVHcem/v96Mjr0mgGfeAZAJeW/g71K7ho
2H2fuGqNtyfrX8Mw+5wGEL+Raj9iho5uE2W1UhkBWoziY0SO60D86dyHxqht0HompqoURQ6FWzm5
r4AivksAJuJP4GTaAWYJzqBIPJTbDMzo3oB3BUi7kDUloz5LfCuF0+BTGXxBgkVeqQDjr7IW+l8z
m3lCVTtbbhNbh71VL9Y9bXK64qYHKACiErbtQeeS4cM4nI3bBHAiGNjsZnIb5VvtecgK6W0zfPXg
yZ0KQd5ZK8yNTvyGB8VK0D2afjkWC2C4Vg9W0IyVyXlbdU7xQcTOcGVPXTtvLLOJd8JOAZlExWTv
01gHnowf2Ag5xaH9E1cpIIkmdcJCnRMtrOxGv01bmLZgsi3g+KZxSmj39c59u8TR1aBtiAIe9pbe
cehE3AFGrAJlO45QYf2oQuwCr9qBuLvYqb293MJSElujqxffTAv9GhTGHGiINoZjrYFiSxu1Oa+7
eX7WVQhuNLxhnohOuc6i8XqxOwWkk+2kD1LqFLtairrCBw4FxEADyHQijLHe3iPr6oRuiugX7WgV
58dj9jA9bIF7AzDIzgB2LKuoOKi1tcLB3Krzu9RKzlS9iT7ATbDgaPU0Suwl7rYObHU4LABUFX80
1Pmj2hryY1Q2TRr0UT6C+4tEcjeAdLoFud7je7/M4PYI+ZqA9g1cu9GYsq+RieWL32BeEFal0obC
WyqT+8xInhkrHwIKzPhkqWPlBv0s52Ijpqm5XUYpw0hp+hYt5zmfYHwkD041Rp97Q8sCIAPlnUyd
5rFXeezMWqDJLl7T76spToDSla7yJdH7bj+DvXkWxFl4ERUoivd12c2bYQFWQ0VVuYEi2FzX5Vyk
vie19PbXR9B6AfwQ+f81/bD7bVJwmkLa8bWqwB7tIlVhNRltuuucCNsxJ7Mxby7cKA2muEPlZASz
7iuVzRRpsYefUG/eUT8trEBR+BwC/0azG25SJ3PMkBarBkYmRtSycI32GuqYRx8VULLlu2OcXXpz
Q2m7XaJuFRJr5ss+qvdNUnWj3yHfrvmqSbQ8iT4ORm24mCOBPodV9Ca/pAB+a2eEUBJoIo9VpfQf
i6Fe5DbP0VitYRhcVti/gmKy8+xeYlsBwSqau8BQkfmAiRvXOS81Q+MwR2W+gBzha43ZwMmP5hpN
C1y6DVXgMir08hwJZnEJ09KycevUm6tFmVT6HWNyVo8jmJt0kkW+WQqzvUjKFWzZQ2O6SXX7WhHu
tKlA1ST7Nr/V+1YF7bUkW5XWwpaukfPJnktLAAa3kvvOnaCnOKlyrtZxjzCi1VxniGh+sdtiujBL
o7jTF889lfS9LeL99elXfQuSIkoT9nEbq9AX2MCa1IHNs7jSuYMeTLR81cL2h89h2Dh/geGsydJP
gAlee0XHZxidAGo+dIExiFuvrB/ibuCLLqipTA+E3uAOrDTTl4xy33ln6efCHYoD6Pp2h21JycZL
AjySmw3kxuRS8RBv9BqWyijUU551rxfu0WOh0o5LAtLTq5TeUbqjTWY9uQVEVG9cHSBMZ9hlDTdS
lDq9v2TjsjUag7ICbCJfxTQZzHKp3MV1JIM6gVloG4O665Ez3ID3Us+UFAVNdHviC8D2U4ktgvGN
8KkNWmGdckOx3tnIJJQEE6+WKNQN3k7p3JvwwBOuBdhz2YVdZfMEP06fq32Ua/cFxQRIyKqbbpdS
tnu1KBUZZHl3nTfNn1DkocAkNGBqf6jSGibayD3tW51aX3VmXkch3aKV9dhoF+z0vPK7Fdfjwy9x
LrNogiLulsXByMzozsJK96qsUlaTOoPG7mAlAIc/h4cAw04ZPfecMrmZBfh+pFuBX9C+yzk9TLBQ
n3XpJvdFlGmfy1TTJz/Vk2EIFGohd2Yu6sDprOlQLLN9ocr0Q2uX8tGBzLPRZmFvogx9EZ+UPjl1
Sx2Zl7zuFeAvHJEo3qyx1FFOlS2Ah2ZN0wJQW8tDZC3RfmnLidpPitXUosHCqHg7qjXlOTrCczj2
EwwrsvcD3Y+VtOSo/jL1TSidRoNuZZsnEkxjfYSjxYv+HTfl2mtREZJ9uwBEPMxgU1VO8qHMP7Wt
4Z4rwMWN2NS2VWbbW1xHjB0wcBwPEjsOurb90g75eOa5Y7bTKcT6BSofgVQIdyo0rg9DaSu7FM23
eJkxJIMA9aGdF2uTm0l/GQl4hE2SKSHXp/Ulh6cKtNxOdnALyz1goFMyI0e9PL7B2voFMUKdkvAe
TMfbF1TSNHIp5PKCWq7fxKzLM7U3+0CFfAHxgwJjjdjAhVa3E1fIBsDl4E2IHdqQbKlqw5Hv7WeV
a+bU3juqf/71ZB79CM4MBENQX3r7ZI1bRpVql1qgVWZ2g4bbECpz1weag/iCqxX7tKs8X7qfbQB5
JChnUz96f6vE9foMAP5WsSIkdlZAxNtnSFPYiii2Qqdqxm9Watr7wRu0LQyB5UQ7/vVieLPSyPqw
4iWf0FVvTbTeDjWJOVMKFSk+EU/FzVA63kdnFtdZoZdXzUo2gXJhNTdCr8TX2jHij3S+4R5Gky78
wbKUc6TTU+nDHtKe8rrfe4uMU78tzMH2l5n+BuiNZZchE1L5UEzzbAeIerl16yJ7UNusiYK87h4r
6BCFr+FjdObE3uSGppGdaJW+1n+O3pSeMZ1jWi7rZj1aciSasMaqVg1GIo9NNWHMRFu1uhgTdwGK
bJrhAAPkbp50ml1ZnGF0OprX9QpJ2TT9iLYDoNx7kUHRgU8xZDHk2KT5BrR+vmdjnatANx7KDhVO
v2gGiI5z6XaPrbm4H7m2re2gxLX0tSIn1LVg7NvxkJp0EdsFFRQxb0zq/UEGt+raKJfmeUSG51n1
yvRLXNvu54Iy07lBU/VplCbU3Qbc0kXe6nYNcQUmN3yZGtmKJD9oi6QtX7bUYFEuebBlP31u0CoA
Rl1/IL0btF2TiHpnahkjqVFoJUJP/1rBf6vs8m+LKW8KML8szvw/WHZ5hbn9+7oLhLjHtHv5seLy
+hv/Krm4fxCU4N6nOhzudBw52b+XXGz3D5M9aAEzo7xCP4Lc/nvNRaPmoqHHDsbDhTb+elx+r7nw
I0q5zooBpI6Dp7P5d2our9v9h03CocxxQzRHZ5vOAT43b4+DetYzdXahQzSl1D4lKGdA6DHpPi9Z
t2RBPrlt6FkL5dWi/UhAqt53phmhOgsb0fIof5rq8hlsQM+VlLuc55qIvtVC1aDWJMsITLHQcNy2
DAROBpLTgYJDuEDb/oYaif2h7+OmQN9n8r7kReVexqVpvyg4TUJRgEN6mCYdzsKUu/blOHMNzu4A
AbgvE2408Nw+/oDRFwelufsTqRWvfTwtq3AqkmdoyCNQ+3ZakDknLEAsaiOGlvjJwRQdxV1IhsJo
N1Nc1QeYsZClFeu70Of/jY00vHSy715+o8gpftv21fOjpGT4/0Elc+3h/vsdtUufusdCPnY/7qn1
V75vKesPKsivXRr2FBfZuqa/byl+xIIGFUoHkbYtaPH/2lKG/QfFCq55AzADuKI1mf6+pdYfUUgC
0Y5+NA4StC/+ThnzLzTdD6sHX43V0WTtI63yhwg7vl09+MwmGY34PzXNTw7LoXko77TPa81NImnk
Nxs7fM7PyrMkWC4Qnmr9ejfu8r1z7p3PL9bF8CwPXMBX1UNxUK6LZxg+G2tfPCxJ6Hwb/zdz77Ub
ubZmWT8RC/Tmli4YTmHkdUMopUx6s+jJp/9HVBXwdxfQF33XwMHBxt6ZkiLEWOszc475NsSu+O4D
2av3q8eHM1K9dp9EdFbHbT/9pnhKVVd4+Ed9cRMH8zu96v+yqDkbJ/UbJAMgQgUj01v3Mpz6gxQy
H7wMfhnWPr3avnhTb+1pDuJbvtfC5q56alBe10DcupQBjm+/VEEW6YnnhPWluc2vM7OZ1O1v28ne
LafxbdiLu3TRftSD7qUhCI6TuSuejFDsYn+IikA+WCG2r3/5tTnwUz5pRyuK36r7wxf1Y/+TcPba
kN29JBpN4sRcYbpl79sHcYj5plBQLk5oRPJrslzEoXWuf8ZzdkDZfkie0ut6cC7rG2/hidfwTw3q
MN5vbnYwPTkwjvXFci23Dcvn+EXdcyF6qdd7L3hPgypoT/JBO6U+aKwwfcIYdKjDImg83R/cajf/
reOwG4P0w4iagxI6IYGVEYX0reN8ko7xlxUVO4g5pb/cHqAEw43DzJVgEQ9eZvoPXBp/Pj2TSJT8
KZWjVnvz0diPnunV4XLU+LkWRMZe5dmfw/PKYlr38EoZH9upirJbexQ7tqv5XkSGb3o5rwslCW9L
vk/3VlhFzS45qof6pf+SnqqzfeU7vJO2ErtykO5p5Wze9mKX7UzfumuR6N38N8GD/V4cp8u8s/+t
525wp3fnDgfiXTsOz93FNl0l3QFF0uXI4Qc1XCmSn7JQCWS/3VEgh+O3fVgPQ+2xJA2qo3KRnnk+
Jy9L60tWRVaouM2Zv+9nnupinj+WjARCi9/IrvTbTwp/V9wYPQkXgpP2xJtW1Z7pL1GKYV32lZcl
DomblKpQzrz2NIUzuC23+mP4iy92yIZyLzlfK8/Vveaeh8ysQisqf8PhJUlc802tfSZWs83b9MWg
InXtAMyJxyI5kEgC4acQX9V5O9bhcGkIlwVLwpf4zXmMZG/Zs6TSFbAKCQiS02Pw5HZjqJgfI6gH
Z/hHaQZb418ZH43KNQ3YLtGinQf3+tOHmG6XoI6Er/sxgcGyp71Ot/XZeK2YVdVuWx35dwbwndVr
Sq//IcvAXV4xXSoe7kQcBN6qeiaPYnmCvFZTPOIJrA1GYFDpDqXsDmsk/yx670GkDeQg3umdu36L
w/Zeg+BwDkkgfKg++YHL+GW8ohXHHIF1zVsOYl8HhfVdHrKL8SLIeTOj1XqOnyyOpSFcD/VJ35Fs
J/81XgUrd7+/jM+tX1ueooUoW8+rC4MKz/qbHipe5pU+PDfioOuwoVXFro8rv9TJkQUvqBduji89
3SelNw+84LO5veit5ePPeOkOfIJd81VWIbq4U3ObJt8COFOWrg0H7dxc9V8bi36whEC21IPA47js
rfJcfmfP0t7cOWpYu5LYLf/IXvFkEbwDHnJchuTFTQr4TO+hGBl9MGjfvL/yB0msqv5u+k7sVX/b
7l0KCt0vdi0QJLyLW6SbAQwrrQzqP7OEsz6y8IbhJuuOjH/6T+a+LuXMXXiE0Cu+mR41he4ngEzB
A0H0J/bQQnlnMkiH85UymsRVOftl/BNnZaiF2vO4RVV6XRREqgc1KN6w3iuf+tFSz/UrDMTqfXwH
usQ427UjrA4YyOedjPLe9L4sc/cgPL0VaWiab+QAOfI7bu0mmlNXHgD7BT0+yNrfPkbHN7ZdgxJ4
vzrfvNfrs1bwBefn+dl645nyMDEtT8NdnjzifhkBd4fhVvjPBGwZHpOyGq9OuM6/qX1KHNyW/vze
v8s32XCnUFYhSodwJHaj5EXa6Nev0tW+99EvEaW1W8k+yMn2LOnf1pkZmzd+iAuUJbcPjXg+K8m9
DrULo+HFcOsva3wdYShlwtqpqDabSfKWH5IqdzUGSdfaoyrxBj+7z8EamDF0u3PuM/FNX/g6H6WX
3lILQssc8uFQfCk9IIBpz6pzNv9QcLqZnwcTMNV0z7HhJqSlme/agw2xE6xbFBE0K6xE14bSoPsc
bxU0tsmX3krTrT4dHWqBq1bn7EOuP5RLN3xhZLdgUyan/p82LK5of4zu1bkYxXE8VM5Jl3e+CEaX
D9XoT4v3OgXB/FMBAs5hHnm5uwhXf0+23+msQBRsW6yanJNBewZhwtmOJcldLM7Vgv9wG8MhV911
wn+fZfKVC6t2zZ/edje7ftMzPTSL6p1QuPkM7LB4jnMPc7EzBfUOIEF+GPezjw/+j323nywm3f5w
BjXWQ1j/w/8N5/KwnuKL4VW++INXec+34pfaehABTzaDduyVUbs3uVz0r3Q//mkptI/jH+06R/rR
wL89gfZx8dGebOGDPDCuSmT6o6+GvNYZWEVoLTv+IdVdmfkgCYA8aE1YpxHPKiuebHStOTLswCIR
sd3n2SHe2DBGg/E+Q+n8Hfdx5y8byxnWOodYJW8rbKzdIT3wkPE0T2dSbDCmjlHmf9tRusAoCU07
nM1DPFzl5gB6chn8XxkL73+P6v6v6vOXpuJ//7PQ/t+63N3f5rGX7//nH/p/sMFVHjmN/+dyPBrr
5Ltb/9di/D//xn9V46r6H9S5aGMeAOEHKJ0V4X8V4wpVNUFpkB2xivEPD6T5f7e3uv0fDzEBKgNU
yPyHR+f737W4bvyHhWIOQwOBxEjLKNP/b2rx/wrU+P9rcXwn6NbZCDwWFnwn+3/aWJsmB5nzmNv3
tvQV81iK8jmNtyHqYSdEmgoZbB0gLdv94stq/DQZqRwRliH8HPpPaDWcisWDB5cX1WusrmZozZse
jLAOmIfPENNq0HBLvs3BqCTaudXUIQJG8a0RVnRlqUbEwAOjNTTsuIzS/Fxn43eydtUYf3e9WgZN
a49H1hDbFc22IIAg1jy1q9OjmkkS1MNeySiJF+eAOC25LkmzeNpgqLstpwZsF5b0inE1JOcrX2sg
mu12yublJCnc+ZI6SLvUlFDvw49kICVp58WUtECWBCGyJKM2+NRjKyxB1+xSVmf3BQcc4AMnt1+S
tEFHDLwgEJVsvy0TQmnNyHXF1/psYt/HvgwwF9S4l1ZSq5GXKL20tpZBHusEpE01md6Lfmk5Z+OB
E5nxSGSPnc3LsRKOOzHKNEeWI72M/InH29kOc7AYqRaM8mBQMi+w6l0MD/Exk1LFFybQQE9hewBq
wEz8dc3myk96AxO+lNbNB8rgXW01UpA2a/u1kXhAcO2a9G6W6xKK+skqnvHh64TpNdvYB4/M4sMq
54kTSLxQqoA4k07gnVnNTyU0UmvLsiAe+NXpGcxjbvokBlUFXgLGC9gH4HeW+j6ty7jP07Xa1zi9
Ijmuf7RV+9uU23nIHpzVRl//lSW+9iKVWDo3eS7O87YdlfamJFEOPAMSqsEdKKDZEXlWQ04GleVa
6bh+rCByjwuKsW/4ukeFanMj7cdDP6DtNqG7lb3qz2uCq7afjB8h2p0kgTywHsDy+E9TJBfUyrt6
kaNKqe6dA+cDHRO/1WQ1r6PqKH/7FPQOkoPu0KH3ZS+f6v4yyItrlwrbsKINTDEd1dwud6NSOVe9
GnybungxUNHGkcOG7ZS0WgUIQ6JcNbo/uMqjrdbIR3EkPWPK2SXbQ72chdkk13tsHc4THAsk4+Wo
rm8rS1YAYpDyQ0eFu1Qi4QjkQtx6mNOePbf2C2qb6rasCIPrybBdZZqlaNCL6cnprArzuaoFif6g
npnpCn63gD6W7ByrU/fLTA4g0Dc5KPNyee0EiAIk1tlpbEsr6IQc76EoJQjlS/tjkhpAolMDGiYf
4VHIQ/ua192nhffdReHI7mXIk9gF02j57A0kDzCHl+v5RzuTeaZ1QgEEotl+pVugXozmddo68STX
SbIf1RiiBuhgYuzgTyyakbHDnn4ALVHerx0/V5yvKUoFqA9G/4CbNXhCKCQBxZD97DolqKXsAYJR
y8Y8I7FM7pUhzSejl+SoHA36lNQxP21Vf5ZS1fL6Jn+mGTtIrcYGRbEdT3OQQmjDlN7nEsCzpbT1
Hj32pamdXZPyqothdeOCmcJw3rQ08wFqmEd7nMW5ogPKnGcE+U6Q62bvASR1Tb3499BHuCrIRkAu
qhwadtJcYkJxRxKddwwzl722WdY905iHPI7pQ8vZzzOoJwFMb+sshh58JS1UkUjeSsbNPLcoN+zI
bNSzo9Cm2fWuBOlMtTrt7Vo7xwOft37+gbUFUtYxqFdzRuBjgg1uA9BXW+nJaG+ppIPC6hEqj8TZ
JFlFX2YX5inuDF9blb/CptDn5Rymtas8p54Br6Vl+9rVsHnl3rxXbZXdnHozwlIpIMTE9hYuLFp/
waxYTP2L+WpUWR7BV25f4GgHWb34WWFmXgqoUhqrt1WvN7ebFLcwjEM9lcw+lc9VkSsQedYRSqLO
Cgw3s6r3zn4xFBkHjpm9YBoFeFUzJ90LozosNI1GnduBOsutJxc1S2uwDauvTtbrUgNvg7gsBSxC
+B0UBDs1Y5/y/tdnMIQZORRlHOnGZnra+tsrOW3F2FY7PnRLlGnbO/gdldvBSPx5FXCDkQtPWjNR
8c9QDCsWKde8q76BdyTh2mAGQ/0KZHQzvG6al0Ma1xTP9ParAy142NSndVUiqF7SldXueo1FVnit
Ul9guT7bcXoslIYfTC58FrJXADKfiHmyoIV8F5iqAPyUNCUHLjAhi9PHs6rWU60qcVVwiQetH6aL
KfXAPlYa7K0JCt7sJ7Rz2m7FF3iGw7O8TYkYorLc9uxHi50B34fH45EZqLbjQUvlAGQhOMLTin7J
zWtB15rarQKrHSwcnKTGbbmCk7yJ6DJU9j/tx9SvqisN7XNFWNehRk4FmoV7M+mWeD8jTSTXBwZK
I9AhYpK/1T1YB5TRh0Srd+jXywg9k3wY1k1/GZSnSc1nf9wm0zdKTHRA6eSgIW/q1OeflPn0tDKw
WDdvhrs2SEYUrzxb3SC9p0hqfB5CJbKE7FzHYoWInQ3tnjtCj9i/M1RIVCeUiWFMPV6CuQPVBzNJ
6mgpDbBL/G1ILppd+ZsxnuWKX83YWa8aZGbNHAKh02lUioDolF6cpPrtVMsXfcm9kcY/8NJad7SH
zzJp+bP5QqfKRROa5HN+CGma74nNxRfnsuGBslV2m5MuJwh9gytPpvhKm27CHriR8WZRiGUB2h7k
VXYWVaQseunczq5DfBHn9xhyrL/PgrHEoOxWNDawWU5L8ZFUD6jMB/ExT6ZRXsQK1X9pdkaOqwok
wt2k9+6196VZn+vcuCXFHwcqquaUYeI4X8DrfaU4O3Hm43NjifmhjlyuU+9PQ3PRR+ZjIEnbAhBX
KthNQqvhXMT6P8eLTAtC+oiydHDDu72ZJ++6LE1+Jpt3MaVkOM8Y9uxOuzZLwlXVBNKELGkARwGs
e6exOm7M8qBnH6swwhH8+26u6u9iKS8y+J6yVZ8lZ/5o5fRg6OMTaCGoc+I68MBsxHG5Q+c0fq9t
fdBbWYcrE2QjTre9RNkK02/N/HgCTUuAWPJUpkm0tWrr9w9VIHBur6zqL8BfNNGZ/SUVsxr0PY+L
jdWGCYxtu4LP2mOcY1UhNxmCkqKPg1hLjH0uTDWaC+CVtfy5EdnhsdnavHiJr8KCga2DkPRBQm2u
WPTnseRXiYRkDCwtE/e242uZ2HR/Mqn7StOJ9DS15MbuCuNIykK9I5THRoaxembaMTnt0nOFKDV1
rHNnzDxcEhNR0f2uqXNe2fs4S+rDuwofeOtVaHqgZV3vaY8fyxIds3abryF7SSv8zKZikpZ0/SgV
CFlFPlUfPGgoeqT2vSzmp9E2f+pRfoaPrzxJcvmX6qw9NASXf2iddgPNzU9VQrBjnGRKz3ql3Oyp
51FSp/ii9EyEYLWPcb3rOAx6xgq8iVo4GhD9AFFpkSwnzfc6JfkzxM1ln+V/YXx5amWHwFTrM/xQ
KexKLBJ6v37Jesr4dipU5HStcwHhWvBZqcSdz9QVmc4v8d1BoyuS20iVvIdmRfopUkP0Eizm/Y6N
+Alg0OyCWzICISfHpu8fY03deh4kG8+WUazrq5211h8UAraXNnNxikWe+knCBS9WZMSmsIdHuiqH
eSNIU5gXzX14CUEsd5jNiwwohmle5HVbg7hIKDESxiyN2p6aplCf6JTGYGiKzzGO76w3s0/UgieL
m35oJ0xkLVW4mZbiWCl9G3Ijoyku+BlhbKce9k/9W2taNapmU3KtWJX2jS1x9ELH4DhMJv5lPotj
Qt+AM517H8l7dVQh6ByzpsgD5SHuVTtjROjXds9LujG2jDPAY2z2X6RVKXzTQujMwJe3o0Z/sOe2
FEe5cxICci24pavkBFqZZGPgFM6X3WZJOCRqwwgFM9cGM9GbqhwVInI3l+TghpCHZjy0ZG+4Qle/
lXZ2flc+H0wEk/xel0IOcpFDkbYG2Z3l9DO1Cy2UTLLQkd3XhwpprOLizun21NbKKxgb2ScEvOEh
dbofNZ5EWPTrsW4T1Gt1oTiv3cg9PDmSCWNssA7apqZ+Y4MOt+0NP2Q1rSS+Oc2bhDuoQQJhWJcl
5UhSZ4VVhdXr7FfIKZlaqOsRavyYCe36Pq/M0hKrZfFiKuV4yZ12jZJi+UyRddS+cGxkErVYxRkT
dHzpikLFQ2Ktu5WTMhhaaTsXY4+ka2vFbu037cuZGzUczWE+KDnFgGfrnMQEbMislBGOSAXg08mc
/WGrJ3acvTj0jiMdnImuWO23V0sp5Pd5UhXP6Mf5DX7H8LasCUKibYThlrOAVR5h9lZSjwj5svIu
LwYchjUR8jHGPeyT2rAEiGP7c7nGhb+MuXIRxIk8nqPu36QNs0faoXrutGGXKfV9cd7LOgUyP1Rv
ltU030paxYzMhcRNHquRKpUAFWvxgyNI3xH34bRuvMYzg9u03VnyAkJ2NWIQ/Yp+zTLjk2hu47WZ
lM5btprdEJ+z91VtaWwM5CikaS87JmQdslfJOBepeMk7g1CHWTf2iAYrntbqc6h4vuJu8dcuJ9ay
HCHS9ZTyCD/to/r4RC6F81YobXEbNXkJZTgnfqtnVy3p/9ULqBwELfWpsYzlTHe+XMWkOMEw1h+T
0ce7CejuqSV5w6+B2nAcJfPRkrm38zkG21sVBqzCZstf5WbdnkqQMNyz1Pq91M47bpAtBRpsTypw
N1B7H/bYiGgyBjPIptgIHWA5aEEtK7JoDD0c34o7mw5bE3s4SAqvJZ7M4TBh9drHDD1vWuKsYC2h
/zUr1a5fi834UIWz3holV+8UasYf7OnD0yKP2UgRqM0XwZnOSZTqvxK2EFOrpj3oRxGIOK5uFdRm
ESVZexWD8pPMZJaJvSruacNK1oy0of6zcqcfqm1MPadpyUiwSGB2LEGgijrn0smBOHgDG2W4SVFM
b5rOVSuJpP7hiVwYJHRSVNlTcpLGzNelfLuDYE0+eOPzI/k3xV891tnqSJ2xswunfCmNlYP1kV0m
5O1FHXB4SGW8vKWV4nzU80DfMqvic5ky1ryxln91+mhTSuEC8WDVLp0nEdsawd73iwYK/YT587fB
ipl5A5yKnmNJIfGnG9dRDqS0YUUR29qWfsKIZq9qJsNxSLVEDUwblOtu6Hq98PRFl+4LRS193dQl
Hzow8YL6vxw/k0VUxDHBEr7XZt1cC14jdD/KRs9I1oIEEX22AqMWygXHirzPNARJ7moLaPu6kSpn
dWm1d9wY1dNSqgvVg6Kz8gWcAj8K5f38PC412FaNbwnxVphPcqaUb1Kr6PtKkbY7KcR0popVtvsO
Nq/jQzONX9KZZb9LSoh11Ylr+BuP6eLDwmCnY9pN7gF3NB+6tdw6QtTKdo064iAQIrV9GlH1j1Gy
LJcBx4cFNPGIcwmNh5A0f1U2i2aBPYqWo5GcrWY4pKAnM1dGLlcczWJu2FcgMvuTONu1ioX6ClaS
XUAt+qPaxYxsaK1crjmH1VBmCNNDwN/6GQr4zFfKrd+psf1tpEQSjU7jyWMDw1WqEakxCDikI/sZ
rWzac9Lmy94Yp8OS0zDl0rFOWZ51iqcLIpH6RIQD7ciY9PFtjK020qm9PFE3vTf2HZ37trgAiKCk
2tuu089tJRdeVnJDxuqNV7FXjeFDNy005DgnCHfyR1MATq+9nJ2oOX2IGRuFpewqh+1rbHp2Zruw
QhNK1/tqW72PKJBh/OaQQIH0nmu9EVruGVnJFQO0SiVJo67A4ueevLwVpXlr181XqznMVvtFh7WX
CSwD8xLN5d+i50KbMAuYmXknvqB5oTOcyK9PmEaQYYQZDQ2RbQxQ8jWimsjU2o5mapoHZ4R+k+U5
IKPkZ07Sv5iS1pOeFZGxGo+dhEkWlAr6MdPLN6YXUE0ZLGJj0lPXsdedsWT1DtXJEZ01vWJqHG3N
+AGtSk1HaCopJ7ZDBS975aP11LkTbkW6aV5ey39XleLbarLqzg0cWO26eEou1siabaxELfMOKEtW
qqshRdSlehx4RpkXXuzkK6kaCtsmkzpPNuxvrS38LFdDpntB5aCssOGv4jAo4WkSH9bG/ogOAA7y
HRsvDPEkqNDYMwn6VRfrstnK2aGNH1vntY7Rb0m5nt6RKJghD+h3A77SfTyPjaL0fLv1qUlWehOb
FAt55akA+QlzpB9vkrqG+swmskhkql57CUqtCQiZftZB3Nhpzu1jHAFWf1l2RDaOtwk2t5bzskmP
2Zh9BAPpOiObm4pK1mrJPJty30jt17g17kJSWKZ3GSUHUhFV243N8i2nxRmkO6MudaEVMAN9Xb5M
QtSoG8KltLjcq6c8PnXQfdw+iw9z2d2pVJ8KnSFxU5p5UMf2p8gApaMx50xP7lONusbOHJjJsbpf
1wYNix372WzgTYNbT3oPAZIa2Qidgv7kQcFvOqHvufXf8rj1YiaPbPP6Uy6392Xzk1LdK/T99Ih+
IxtgwafGQd9BzWhgxOLZ0ngaqyCZrAOjGnjmncXxAyEUD18RDclwMJ2G+0yODaolkrKknPN68sB4
R8TOnEy5ilbtyuSRsn9ewrbhNolZ8q4zFOeat4YZ2HAo4Vf3JuvbocelUMLeiLq1dddWZoK1WIbH
8O862yWhEQOfNcPyBgTFWGzQ2uViPyU6zPEZ6LO8M4WE7fd7xjMQxF3MZe78Wk0J6bZAYVKwKI8Z
2OvbcJZrVb51/cqaHko4JeVDTgC69c2pVN1viHiJ2ph4AoymLWEC63epsiDWWQKajXQ2Kw68B+vW
Zs/fEf+zMWIb60NKZODq6J9d96bY5BM7zgU8vicyrEoCfu00FiGqmk4RrqY/x9nJyWy/mbrMnfXY
N9sD3jh/Fu+t8pdYvW+K89ntlf8EL9jXotbifWIsxwZ+stuKcTsukw5GW75ipDiTekIrrDZ/anm5
0IHsq5ll99Kd5PXdUft7LUAsMmGygrmnJOi14j3P8h32Ms9s+aUgqwX63x2yceDCXaRXST1nEpRr
C1GUPB5lWLF2tflbXnqqPPhGdVqLei/BoK5JUTqSu+PN414DCVFwhyRrCLlS6k46cyqKIP1gO/Uu
Ll+ZO5DR8Crmp8nkRLG2Z0UdmfQPYebsJuai7WBRgrLKZ8iyyJYXV/b5IV1Ix2Mu3jmKXGoOlxkE
q9iOJcY9oyJd9NlfzRUkmnY1jVd7JB1H/TTWP0X/yrqFZo92kPsAlgSl33Ls2KFbLaaPj16WvKFF
Mc+8Q34UC0P9NEjM3Mg+KzCv+PST74tE7CWy7+Mmj6ibMmd56UlJJHqygZzItsYrVfsFgrAe1ot6
161xPYueuAUMa423DX9h1R+qogl0dbyUtHihk3UEmrTsGqhf2PjbyrGNyxd9Up5ELu07kT2eakK8
cAVWNI1D74FK3k4622Tw7ZqfjxZhLrShGNJdZK+3fEP0YUrr3PIa6O8AOx1VZfx6ABdBW3ejddaq
4YUcxSSyB8KCGGfp5U0rh79cQUw/LCoZDBUnLNLobkAL8nVW+xKj59/NvdN6G+oHk+OXjcZHnCR4
Mqutv83yqyXVT4WCBGhGCtanmnmBcWzucbwzwh2f9YLpsElbIwRXx0IqFTkBHw8s+sma0ZYbA/u6
6aNtVxfwEOkwTXNS1evWcdOquyIrgHXNixPiQ50JBrBegJH5eAmPci5f2vZtJr6O7LOXQiKEcBqI
3gT7D4jxMOd6SMQ9VMDtP4em6pocsjlhXY+nMGQUnkf1lqBCT3vzSZcXYg+G9pzJBsPcB/Y+vbcM
chmzJJMLxvtG+FpOL2Ms/F1KMYmJu6y1ESR7ZkrOnEByz4jZIiDd7XsqLRJwynMSH3PVGKNyWhP6
kFggQGu6m+JYHzkZsvu+F7mvdJlzqa04PmRW4aW8C55htdbZeWhpsuaSpiF8NralcFEb/pprqKW8
k7dS+IY63/ELAxaVpPK+xKm8A2t91G3CGVNb9mHEBFNCnGTc1rnfNPp+0gkcFGPQ6oRstXr/xiwb
ky0c62ZOtzeJotBlpVCStjAtobCpl+YhkKk17HF4SqijX1aztri9iaqkobsvufNdzfpOUafTbNrZ
btPr97WUnpguvBIQE0nGEimtfcOagAZRHhliORMDf+OwpfZNo9Ibe9a3JGyintPQgYnhFTLftcF/
42nboDMPzgavIvPvrPSDGhj6PAXqtPxLqarRd0Ox2JriT7rGFI0GV9hUUGqNcvad29/WJm6WkRVM
IeaXVl7PWaK/kh9ylpjI7zLtwdDWMSfR3u9FKeD0LypuBt4er2vFM0kOTcaKYisP/VBUO6dPf0qb
7R5Cv1rhckzk581O9zVsJQ/8DgLNlQcQBADEGh74uPHhzp0kS1s5dWbWCpVUpwdzyg9M3eJwbqZ1
hzQbNVfZl16ia7uG7InU7Pgza+OZ5jjvswYf00Z252sC0MiFPf80yTIFj4nx4tG0TCnpwH29MOdk
/epl9mMLJ25cvhlBGGoGjFyYO1HPf9uRqcVo5g1IdOQtW5/kXlegIkpWo3sqSu2S5fOw50cjCG+w
q/3QtdUhERpHULuMfjx2o6v1mhWZyvAVp9CjmGGo/tzFqS/1FRQ/5ZnP47XLmN4w2kopuFQlEKRE
udvGcCyWi+XDLKkou3mdad46cZxLOf81O73Z2yLtDhswdRe7NLpWdP1hpmSSbxSyEaC5z8LOTOe9
WIx+L5l2zmezKrym6B4VX64Qk5OPnrQ5g68tUOLrBgEE7hmGSFhogi6Rf4slewf9yGAiz3fKhAxB
1ebSw3KOvshuPxK2SFeVDsQnKNS524teB0ySsAqKEhEZuRRnbdNZYTST7Ff5Irm9kz+vY/eyWvFn
OcpSqHebc6JabMmyYRueddvoOaTgkHBnnht64szuOoy9UrdXNDN/bbbJPvVja+y7kRG3gjDbK1b5
ClvCedra8tKYar3LnKH5JVt3jBYVmyyId+fPSgrnOykgy0cmE3mgN+PKKDRhIVCJLwW3NN3Phh8q
vaypepcm9TGn5Qewm615XoSGagpIQpXjuYQy3/mO4vwWreanzlQHltqRPTlU1EMZOelYctGUUZ5v
bpNzjOiljZBAnc17kumqX1ntq+lQ4uSqjeAA+3TQL/YWJWQgvAxLl0U2wcevpAWfKwxTX+xVuggL
Qucq3XKuTN7DRst30//H3Zkt2Yls2faLOEbj4PC6+x19KNS/YAo1OL2D0zlfX2Nn5rWSQirJsuw+
XLtWb5VHQmzAfflac46Z5/os8zTcFn1xOzaIW1KZT5tA12TBany3dbCvhwZV5GC9XR8QMtOqgsjH
urw0wm7btOrv53n8lIZkdKOGYEUzK6Efs6KSGLUxu0T3V4l7YzP300BDgUQV4haR4QbNpV3F16PE
uvibcQyCDVPZJ+Oa8dhWVXvCLRr83wa9/L8otbrAgf9nqdX589cLvuUHqdXlT/xjfPCC/1xgPS6u
IF5vH2HT/9Fa0ef+DzBQLIT4+lxa1AJPxD9iq0hifMD7Ca+LPyW9mP9k/uG3BP/xgYpIotKJhMM0
4f8bsdVLVIkXwfjxcTSBHQQrFL5wPdjehm4Ke30vGRv2LaILW3QLw/uFN8eu1bZy9Z/4KC8BFJgP
OYb7fNh8YbHrvfCij1GoWHIBT3HOyj8xjAYDM3uPxNtMD9OMZvW7x/EL6MvFC/rfYjK4VlxOBMAo
MWxhJ/7Lg/6d9X1wh7QlRs/sG5kQdSdYqXqfT9ctdLT7X1wK3O7FLotn+aVpOR0hAI5eafaZ56DE
kQkEBkEUQ7JxL+jx31/sYmf66b5Af0NNFhCMX/6Mpu5br/ZArLVBX96poB+POZvax45RDmOjOdr1
EBLmjR+N/a0IE/GH6//qMV5Ueq6LfSfhfvn3ffe7siuTRFA5/T6L4vpaj2YlaKTvbwYy8jjcOcEf
nuMvr8dYDJgXJjo+mh+vR1iN9v06QBiSpozW1q67jZZgIo4wxuBeOf+ry9HRZBAOVu6l57YjZYQs
BNHvtXTkDlx0t+PwD0CBV+2Ep746/f5x/ur2cJi6AB8ICsAS9ePtGavzJp8t4ixytZhcRd6DO1fJ
LX7i7n72gz9By15+FsKVwIEjjE6sQLiXXzy+KqTLKEokWw0HqofSsK2gbFRMs5v8w+9v7Se79str
vXD1JuybBblqiL2bxpzLaGy2WWUQ+pbAT5wsGym2fUT27fIYp854p+dF3KQ6Rdbx+3/Jr26aFxY/
GRpTpFMvnJNzYVEIVvxDCFhtdpYoJgxeKr+mEz8///5SlzX/h++Tm/YFeFAW6wBam3hx0zj+11mP
EGTLeUFSNeKqCFdveSJUsqKUDeaPKkFR5jLK2UjPEg6PzNO/+/2/4uUigTkdDCsKFAx0JEC9BLFq
r0wY/GX1vn6b7507AXvkvXMc7e5fmi85NlCfhV58weWGLCYvSB5BT+Z61iXY3QQKE5/z4T1jADQY
UqJdJTxXnuMSkSgdNhQRv79JNsMff2nPCwWrQgApDRSD/2JlmPIoyB2QF3tRTfl1oCL3hEZmuYkV
QqQu877MSgznbG3kH5bAn35dz2PPhDrJKwXP5ae4lEo0XmeA4xAf25+4CH0apq1XtrMuGgbTkNbl
TMduQn4SZJyIf3/fP1/epz5IPJ+djb1UXv77dyswA9DEK2Au7c0argcIKJjU005sAz1E3t6vIno5
gaXjGQ1DfGqpMv4dlpof/cJjRQLILoRvE8f0j/8C8hVzVw2gzRcIu6i1iy+5aINtF6nm6PVTy/C5
SQ6z5/6JSv3zI79cGIwO2M8LgOXyoX9365r8SIYDGpFr4dFkStpkXzLiPa5u0NxlICXfwJ16hXQi
/8MWf7mj73fdyx1zwUBeCjPoki++atemnscMhGCIIjY7Z7H64Ma12bo12avET8UbYM5/QjH+4m5j
EIAg+y6wEeIofrxbNBUFrE5wSU23ZLAQEE8S1TeddZ2gjjS+92qOTfxEpFb+hzf85ytThsYUiTBO
4pgP+8crB/MsF+NiCQ/qkBZh6bQfMrd8C2kuoOc9xedhQrKXueEf1q2Xu6HAWh97PNcwcGXkv/yk
GaM6xNaSERp2TCuLOcbAuIbBdQy0DiKWc/79l/QTbobrYehnmMe+gAE4efEi5y2ph2QsOjvO1esn
zmXeTvpqIOszn91TvKT9TepItA/QS9VNRtjKrUSZ/zwwRN53OXHCk7DirGdtXjsAe065n8x/eBZU
kT89Dt+/mCL+qoKo+5IXj0PGaTdklQd5hyZmvXXDqV8/ekEbkJTG4bW7k0wqlpt6yR33mrj2IkCp
V6zREYdEUB31OvvFEW76Uj2ZHO14SICmAN3ijqmffySMz3XvYFAK7ylVY50w1jSaZlxHauxVuTTK
nFLRNeHHidTj5kS3Zy13CER6Bwth62bunpiqdL2KVVCTGxJ47sz8Tpvh4BRVVd8FcxB/Mt1aR+/S
wajsVjMW17u0DYizKrN8qjaFMwzPyrGLedBOrzmq86rBN/W79VUWLCNNwyXgOdR+WYr9EhAXSfJm
i6AtUMxQSZ5AugKsz7qvx3gWX0vdLqcmbJDkZwsag5heLZa5KcnecHDAoirr4TKb0HOMNjpxmodV
BfT3HUUa7E5XNcYzs2rnpuMjxJkw1OZTIqZAH1TYzwxYVWLPXYbvhObrxNGZpDv7ns4TY5dO0gfu
1zD9SG5KN11lvYMrcVp6ebfEi4O8gyMJg8E4DfGQJanuWVCU1BzJA6dlhtQw4Coz0vj2S+6Xx963
ebA1uW8+NX3de2S4OwO9Siwp276oLXKEoUetVphi+YT8eLobWxnNh9kZ0ul+mhYMZfmo1XjIc+bz
W1KOR2x2qAnO1ZCHN97a0Q7g7yNyJS7kHd3k9lsQukNz9HuScs42coZxy33nNMlpoWanNM79s0z7
tbmRnqvsDiCS7pi6u87ercvEOfZhOGQHb3VouzZ+Xgsg4TZC9ZZm0Z2s0HjSjhq6fKcjD5lcEk/9
hEnOl822Uyr2MYgtsrzKRYF+iBfDHNh0g3RfEFGWHYO6XmZgVIr5hGvosS0iG9Xe6YpswCFQNxPG
j04QLEJ1OZ4Tr43yg29JEUKwNN9B0sPdViRlP4PRc3BXl3KdXgea0FuwjZp6uJ591aGwd9J6l0ZT
i/yQqdle9IOH+57VpDkIhkyvCZzIeQz9gOXdmhQ37poPePFH0D07b/Cz4tGdA3zMYbnU18jw8vpY
+8UQ3w/Q/ycGSq25Q/IbZNcd5c4TknXH2aiW8AXErG4aP+mh6W/0SidrnzAj4Qp0FWMM1dPIWKe2
GcNGlQf9sbceanFiENvjGIr0QVS9qU/s4NjeK11MfE6d6ZAV19qdNg3bTs1XVQws8DQn33gmSd+y
n+BlgUQXp2hwUyTLS0r7KoLwh7unqoKAcZo/MkDJbPscZYY9gurQERs5JzY/NG7RTQ/IUgr30VdV
3e3pNVSPwkcwdSQEWh98l+CRfUWq/cDP4Y7Jg9VRlzxw/qC/rE0e6FvkR8sTukKvvEpql/iy3lP9
3mcg93lhXjJvh2Wc0l1IXP25yRe0rQslE+GduSf5f5c+KaxT5XrYi4mIcLYp6aztDlroaPc1XjIk
l0glHEbCUfalGHx33UPK828vUYXJjuGOOk2WxgkC+di9H2i8EouUPygauVDN05D8T2j7aGxwjuDo
rZow2ZLr6PXviEglMHjQBoXcVF6mK3EnB3U/ag93ktcrra7KetbDuW1nMnBQ+yTyYJlNm23mV/N8
CK3GNFLVSXg3Qp+2b4gvFthFWWzaYzFAJnslwi4kDLRyMdVbS2Zo7U4km+cRJ9V9HnUphLx+cTdL
YaZ6OwR6fRpKB7coQ/PlQBSP09BhlxgJ0L/jXykhXDc010km2jBb0e6ZFnNx31jdVDu8UBlGYFeM
b6XbS/eUueP8mBB/AO3XRu/rpk7wmYNWwlDKa3MqPYbJqFFS5pJqKXWyMRRmOeDOQHT7SC5zubEL
E6YdUD/GqemU65XNZp6xM9m8eVNmaWj3edoUD1FfAPRqO2Xp59Y0Mve6i+unpY0tC6iNvCfZNNln
k0xI9CjQaF9FTNe/lpZ67txGjLbPJd85LEhkauVxHYfJnEVSYkBtlZx3kclH9qA4z77WWdn1GKrd
PDuiPJNvkiVXTNugoOHyi23KeY2s1xWR1TqOG13Z42KG5ipCT7xugKMNT3pheAXoyZmvVyMINLZF
ChHDG5ZsPdrUR8rTtNJ535t1/dbUYFH36MoiwCJrGm+NGX0mG41Cy1Hbnq47fZw6P/BKsSxl/lrc
rkkPcNWfU+erp8LhEdOL1Wc7EbFDuAFK0MLTEDAJEEPErRwXsscaCCTvaMOrXRCkcXdIi5QPYzYB
qclUR+xEY9OSOD8DXla7eL4IGlUUNOlG1JMzbrKcSoPvw/rPs6rMjUt88XOowrLD5N8k8cV+1x2s
7pdit7Q1goIyydfnzJscIm0JjlkQLZCavWN+Gd13Pmg7TAPRFO7lJcyC/2j1sB3SGUNQrcyVatsv
maCW2AeylXcAZgy99br8NGaVujKhatzdOrdwTShJmudwqjT4L1SRt+yCZsLYZOVzKzrjb5KOqdx2
GX0mxENSCaSmBCQxeFnj0r3Jh47ZYWF7cyvIS36dyaX7UFnmd8RBmbh/snJOk6PGrAp8NvOyLyQN
x9HRGWNPvSE0qbxnxIB/GVMtsSpOWPnUg05VfraYCM99BAdvn0YpZrupzZLXltdaYDdxQ0JzzaUH
spZlv+thPXxO0wIPh/ZGlW1MjNbrqp2WS50ZUPpIESGJmKnbri1M2OpciwVR+7wmkPkGb/kwa+uf
dAwCb0NsPMVCxQOHjEZatLOf0GqAYJHTwRcsLkQMpN7XdHBnvCdYZOYdPa7kYeHork5krnv0gioX
9o1xmL9vdQP3cUfFFF+1jQMKY+3d7BHRMU/LxIw1ttJbe+828iJjDtV4iThb+yDJcA3EzKlE5TXZ
0YscJXcLcG597XimyVlkJ0ROJFB023pZWL2qqG/IR/c9ZlEJH7S78VcQkwcf7JS9Ik02eTu3OOfT
+JkSUgS3UJvzlq2KblEwIAPMVxx34aLfTd6Sv21EvsIJIT+8pIEnTbGZYGW9cdDu7cWUx6+btbgM
g7rUzldlJ+cvfTQW9V5Fyn/dOFP2GhmPaYkbqup3q25n/QVNOoZBMazBITHLUt+C5serNDEZJxcb
pWRJSZt1oHoYx9+gMwEvO4V9d1UQMK0PWjaaVQx/33xesTrJTVLb+rQ6dYRirKRfs6mm4OIuDKeo
uerXtr1krmtO9s7cmQzAV171B5UOTn3XT+6kDjEjnXU7R2YaoVB02Hex/pTqZLNiDjDtClGfKx2v
ALRr4F5b+mAzXqAwxXGpmh5o3Uwc9anoE9AxZL3E63b14+FTYmtGZoy3sBXkCNquiTdzzZEUjJrK
BmLpiaFFIHer0RYX0KKCkzMHLds6Is4RtIZnnp1g9D7rIZuoizK0iOTR98FuHhkjbycl6mxLV8d7
TbBTbiFN44PdVgNDqc2KmhRxkcgIiieYvD7IEDWNgwycuXAf88ISRz7jmxEr/zzlq4S/0F0Nq09J
lbv1hzKe9otN45Gupi4ei46c+o3fec2JTPh+OeHE1hOOayLDt4314y9DLqTl9bTLZxLaENfw1Fj5
pJiHfEdKYQFOpMC+s/NUTqLQQHhovekm56Iaq+Q87Obad6GPyALcfZMXn6aSZszRWJMjzBqT5jav
0oSwHC3z4IJarN4VdDia3VD2fKF5PMqSTtHsn3sdEC1ZCkpdyklPYJ+R0Qjosa/lshFx14EzMvHc
bP2iVDVV3NI1FMJkPJ/j1ZNHl0ltgvyqDId7ZKRxsaUxl6MaEMahCplnquwwR5PDdEFfkiwd5CAd
DpB3gEXzZad6nBujWJBgOp6uMA4jVB43jBiz5mqp3EnsfUo9FPRUr5spKLsHVY/ydba45koyA0We
O6ec7iJ3mQ+tCB13P/Jp9wwk8tGlOHMGcDM4bvYBoLpT4xh/2ozOOL4t6UlAfZJ69FEn4B89kiQf
8kD5WXkx5UUSiLxGR3uNn+dLMdP9uxJOY9xr0sFM8CWOYe2ICX/Hvqjy5pm85k4cxnSpPxe8pXwp
YgT77DQy0LtyZgK3EQ473a5rvQaWhpCVuJjH1qNMBlQYCFszRIcqwzy+NEtxaPyR+bieh/bs2Kha
T5Osnc/8ppgYQtlgTOw1B15SOqfkyraLfcUpdmQDXxHheyLiK/McfynunTWZzr1fJ83G6wCHdmGM
M3DsAmc+OZMEUFAVS/uqnPTA2XUOE+g4I89jU+dm7pl8i/W+7UugQhy/5jdEq5AcNHYIcvgnMdv3
KDzeOlEV9tuJiY0LUt5HcyywKW6bjh0TnUEXrLsmWyl91ZLWNyMdAwy6jLjelLWb85pkguWP/uq4
4RyT+xu/In8OHkwk+1NSBejo1nmgpFO6AcCJV5yKxcNYsFCeQ/gwA1sOCH+UhbLyK4Krw1w9EQRA
yRCDSnlDJiASyC5r4/1ozcRoPzXQGmznmCuTkyh4jnMWSHS6LvQxRL/LYdCqP4zZAsXdXQY/3HvB
gkAizANavgzEgAPJYJYdQq9yPRV1ZDq+K6b4TPsb7zkaFzUfOhSXT7GZmptcDLZ+dGsVp1ulioUK
r7XJAqYhHvxdIIn8vgrohWT3jIWi12JcwX45PegIYUYpWNj8gSjwLK4l0jQaF9dOXdkWUduYupu8
ctS8b+2AfktPg77DIjfaMzyZOTsw7+Knyw1CI7x0foyYrVOSEXyr1mmLDaYVx7qIFLr7DGIXv2ia
PsVE4F4OqC1Rx2xWAlaPXnV/P0aOyb9WeZEBqgoxlZjdyF0xbvEDDltjbYGxMKAsk3NXyMxuehxO
9hSuA8LeoRAAmUjchEVE0yGu6Xth4o96jE7w5VMPB1k82rexiwnxEHrpfE6J/1AY9SjotsucLx9X
XzunxVOsSFFWsCe5uR6/QpJebzJnXFlGUPTPN/kaKWi2ykcgW5Wt8XY5Zcdy0/pejS65kcTOQKVk
/tzGLMM7A2vDOevYL0aym6fuMXXB1eO0rzNz3zjs4JswQFyOolEqBHRsZM5GF77MTg0qe/yNJSDz
Q0VtPO2iNpH5bnV6625B3deUZiILDtNow27nBEv9TVSOvNWJv/oH7BY8EpcUOXb8qYt2EUcsNOwZ
HeJtkNEk3PAamA+SHli8jzHzoMk28wRwIxlmQBVoZj8SGkyFtgjlRG+WtR5Djt6+B5R4zcjvZVT8
KG2QKWxvoichdATOsIN4OGAbi7Gk3iTR4n8mpgAGBktxAVzfa2F3LN7Fscmf6fHqhnnhbZeWzRwX
igNni90K+/VEHB0nikFnbwAIN85WNFOPMn4wIPjDMh6Yha0z2StkXimYG3UMyCLrnJmYjdp1EGHa
VMl9iQqY7L6g9zMMpWWc7T1Kz3MJtlztimIeb+klkFXBCjLDJse/tuzAFMCnI2K49nFK5GjiGbjl
n4ASj3eKopYP9UIcpmqeggw5LPslB2nCBPDyrTCM65yzeuotyw3WJowC+GvlzSqIhtkWkU6/5ay8
z/UQxW96xywCGhSSeuTcExOPNdY9wN8ytFeo1dq3Qav6ZRNEKv2iLNSMk06s458UJ0l2FEM22bbR
nbynQlztKZryenkwyH2RblNsakT7EDu2JS0Q1p417skfKQZzV5B/gNkeneOz9EjA2dZUZl8dW8ln
d+jwJa9mpGuxxKj1TROBDKkqui7XLY0bhWwRPHCRMeo9DRE88DMcEPdtz5bzTkxYBDZ2mMs3eIbd
L530Fv9Odw0tsknlQ7BzBX/wTPxndmx1l0UHXCsFmsDMZ3pMrww43yo+M647arYbfztlARwMbLL5
cTQBZ9i2p7DfoGFbHyIEpGdb2PJLgC82YWdwvGeWj7F7RQ2topNJrYyRQFJA7OgzlLzvHMfUHhcz
1QitIUtnkUHQl8wQcr7l1IzYnQ4ZBEdDuP3eyJUHLdbI+Wg4GnJgTrA9HqVFB3edo+50N8KdEOgn
M0UUWj5tdmzka8Dx1DjiZF3c/3rMdbFzg2qhnRiQRAX3hF4DvUd82rr2JUfXcp0AEORyeF8HpQPI
PmA3Pkze5D6P5E8XG1qYjKVCBCFPBRyM+Bp/Hvo8XwyY+byimnljEw6S1xEhDoesG3FIyyHDIu1m
kO52ffDXN0sX7cpHFVweeBeYrbW6WqAKBeV9FawLdUw79C29MeOnRz8mC+igimR0OJVFnKIm2sUf
WepwyfE+ZHdlmWRfpZMpJJ6uKRB+OQ1ZDVMnx/mIaD1xN3XG57AdxQprxOms0zJGh2JBd2tKxj2D
bZAKPMZtO6L3O3ldwHkKGVla7btpSGBN9KNXccTuEAPWlexxYE/tBycvxHqI0glp7cV+ikZmhehv
shgzvlTLcgZzQzBw1kV1fSoNfTyuYFiHoLXotxn2d++cTCz6TzRs+oR8ZxFR9tDGFIdpHUOAI9lA
To9I2rI9lJ6yOeJ4w8mdlcIj9ES0LQZhH5fFNkrHjoMLftmAMcA0VUdeuuHepf+98cIq4WiYexd/
37qC9kk13n+7KkPnNl4vjg7CQ0B3t1F9p/SoaEWpcH1LL4fhVewCp1BrSl/DxYj83oiOToMfqXdj
Mk7hNiyiSW0HziHdJsPf0WxsdTFN9HSNU9wPdqIjCS3nS8GCRVNJCnvEqoOSUIZxd5zLvnvDr+Np
zCGVutaMihLQdOtwLVtKoA1k9vDIgsBJZprXZdzquorbHcpETOCc+IhCrjQC0o2joz5lyOLL9kRl
4VJarN3oHRZP03lvKJ850cQF0SQqW5nme2tNuBQTyGm8Gcrc3jt5miYHW3lknbDQT+0NqJI6PsZr
lCSnZXJrqppsiPHUhnk/HHxPdx/o55acgFag1rtsajrgkrwu25nJ6HR0Or96PcC4qU9hmCHGR4Xj
oYUc4w8l3VxB/oVrHqOgD9vronKzW377YdkVKDnu07ANBoz/6YwAu1Qu9UtWNPSfTSpucptmsCJD
kFkYe+CN7OlyqXUzyIDHEDP0TjadX6eCIIWLyzzPsvIVaAtAo6aK508Kuky4yZtUOhdF/vR2yWMH
48aKA3lZmQbt9BD37yG6c9y29B1SaEOebHaxDBuzUybkhOVFZU6TtzXlx972Hschgqqb26GAArBp
k9X/TCaTutjQmvhzBMv9tUDyj++LXu+4Sf0FI3GR+eUhsyr4Kk0PDMriYHoX4Xg8YnWilZikDnpb
LWtbsEFGKUAlhQUSDBNVK4Ki+T3agul5mWf6JGmOjtoxl2ypulst0xG8mQKLLX8/9JSK8/+YVFW0
b5tWlfvBYcJ1hCuQX5WRRBCdZGsXn2pjw1cJJyPwi2aMzIPipOzRDjLZo9FmebKV23l7pN9tfrQC
Dcst1R8nFhhFU3otIMmkr3LmEwaGtnLnb52DGwWG6iKNfMO4JQl3lWX+eGwhRATXDOwK9ejXUBTu
xmWZ7H1cFDp51fp9KW8EdJ3hY1gmcABLUpQhq+WFefDCskZ0KjxiTv4gCflpfgwZHU0CAbsgdUgb
83+cW4taW3I3UC4HaT6flwGrhovYfc8iFxwwzwx/uN5PsgD0F4DhEfqQb+mi6vzxeuBcelWkuNgi
rVigGSfsBDL7UySqgtYRbGR0IsPxr6n1v8Ia/v/J7/cuyL//WXP78LUffxDcXv7n/whuIfRHqCQQ
IiH7RC0YIJb4G27oxEQf+vFFBxWS4Rr8FVb4j+DWcf/DOQuoYQIYkQk32g4kJeZvya3jxf9hzAlq
nzkLy6Tv/avMxIsU6r8lJFEgQiQNvNUwGPlL4+jFu6nCNHOyvgD365KbxRluPUZemf4h8ulHqcA/
V0nQCyBdpHkfvBBk9Xr2265EQWF7/cop4qNO8k9qkbeiVYy2yunBCdpv3z2Fh7/v4ft8xR+/gr+v
KUP+j6xK9sqXAVdNrJumV6go5tSGe9dJyWqKxxTU2fppmSZAho3vb39/TR7LT78m4jaedoAIlq/v
xy9vHkoGkGaiG+Pk77xEYbQ0GYOFMPhTpvGvftEYYSYCVMIFkpcKTY/DtsziAcjTYua3beOiFsnc
6m7OJm9jm9Q7Be4M9qhuqj/IU366R67nI86W6LzcxHVfPMuESiNk6tztpyLGiNGKwXuqgd24uzL1
1fiHX/Sn9/Mi4vMCFyVfxErmvlCihoyGMzqO/Z70oxD0q5kOFBnq9Pvn9surcCUwpCzSiDJ/fG6D
ZZxQFRGa0GpJb+OGUTv4O73/d1chRdmXgtEp5B8Bo/TFVYJGB0bkpD5UQ2MfqFQdKh6OIr+/ysvn
c7lKzLd2EUoht4xeXEV7SpimymBTMhPYtLU3P7VBGl3pzkv/XvPh0P46cPXlz8alJJdBlkx77ZIC
8uPPVgbhEDo1scbWJhGbPSXoXE/yD9vZL64S+4S68oCBvibhixvq7VKN4IY4VkGe2TErGTYzZ/J/
/3BinwQTpHSocYnQ+vFeUCVAHtIo82cnjjYGZw68N6R1v384L++FhYG1niWQYBBiJi7g3O+lghb6
aVf3xbKnZV6ccIgvEOMGh4bw76/zY8lBWlGMIDG+LA4oqmNKjx+vw0PogUJADZKuWfY1DSqoM275
gREmHBYIXs3D7y/4QlbNFRPeAilQQfLOEgz1ciOp22acptile3hRdnQB/CHPKQ+4IIorEelPmaiT
43o5f1kVQrgQVY4TFcvyH/4hxF1xc9/vaQgTeV/YHam6XBHFL35kOuYr/eaaTNTMF9j+DW7vjTOt
sjlr2HMAEkLtJcFOcOBE0lP2Sf02ZaoQPw7pmNmjQx/jq3WFqa78qlvMbUc1vL4Pfda6B9BZcX2V
0K5ADxbUFyzpiDARROns96+cpSTM3u8jfKl1K9b+VBWzfjBeOU8HbIg9J6CpNqA7FYyCxNdodfi+
6pOKjPSPeTYw+F9sTiOL/DV/2BfDCCfUpZAzHJ7zhECZeYbBmPbFuqeftor3GbJfhmyKI/i1m3Wi
fDWHDqwnU2bL9ViETKVcOdQkYjSKNr2yerV3Xol10yGLqxziG06QZQi+yxlvWpR4nGCAfCKhDd32
DcK/nJQA19AIaMKUIYYo8uuiASO0KyHZvNa49+kNjq655RQSEI666lLQLKxruYlpk4AwLwkH3VZT
ClFtHdEWHcIKCCHMhQG6A11kx98z9JPvjOwFWY8+QJK9Ey1MslpPBbBMhQkhxlTMf+htimvBfhfT
U8IMu3MxUh9aZo7Q8rIAiFWdQNUhIcvnTGSE04a7xvPXhSiCRb5ya9mQ08VESFwjAkAw6XD335y1
J9nEFTmN78mk5nMxdPO6zTnfIft0l+yjQon0KiYB8iP9c0njmrElFHNRViONlNlF5FRyfgUUDO2M
Y42eP5hML99w5bI/jyJ7P3ai/5S7aDJ2dU5TYstclqmeSZfovSgsXbkuTbC/amHkTdQnSQkTNXag
GUj9maFLoE4FPor1MKAmoRmtI0m+QgHNKesVvNFBRrySacvLvZGlIgTYtnm4nXxakE4m3bu+i/q3
Bmt6eAw4FKC26nN4JEuBnoBzZRRsXLJ2u4sEMiVFAHRQuZsGVR+dspAfSWnT753aRu/mQDN/foin
qIjbx8RNzXo7omYbgbbJi1+SYw7JDspPXvHIQDsE4ezk+5LiaL7MBhOCC0Y9E37EfGUDbNovrmNn
oMfSS5i+h7IviW7JhxgGtI9WysP9ekFVzRkMMlGmMEiqXuTORljr08tXWeHdTr1XDumHMl77e0B0
Mx1pkUVfVr/Sr/UAExov4oD8KE5mJkKN6KaPzjyGAOK1Jx9tWxBxnPYyFyhH5uZJzaCUN3jDiN9t
fRRTmgYiJCeVgTjxPDW9lmMRoaiMi+R1qWDhnhdUEXeqr8UEPkEEdPirpitv6UqLD86K15iJ1eK5
17RWFsAqPVYNMoSHAnDfSjjjTjUqvPXr2vsq0R7FGKcljBL0yNUWiZ2lxej1g7MFDwnrzyn7yGS3
XeGhnYzx59KoTj05H/wLn8TJfQIdowZe7GYAyoskPEewLEtWrb2JGVWj2sMPTWsrtoSmuI3ttiNK
im+zWOL80o/Li72Lgmy6UqGcbqap7+wVaa4tL+Xs0L7mMJ19sUnczT0KMlfchlqr55YNzYIZiUGs
2HAJv440j98GvTDZsR998cHGQn1kppq/Xb0h+FChIJTHNNOhx9wKL+pOq2x5qsicI+8XteKZGXrr
HWNbUGG4eVs1+9BmDll5UooPdFrsM8jZFnV9WRS7wE1po7QzupJNplYGUp2ZKrEPWj99jdsp929a
J0FWpBUSVybK0v3cCtMRvJDVfDwVX8W8SbMQ4mPEGOwbxzRyjml0dRWNMKvoV9J26s4h/eHTVEmK
nalW3bvKyL/sJTO4AKtF+7XPR2CjZYX4JbCJ9yFc5fqejNYFjzt1BnIkx69K4iByXD+FsHyNMiBa
8xzrSRx5lxnkTUm3fFrdGQxGBeDLbEB+TeaaSZp9FaPu/5Y0nYa5JKgFtqRHr4BYmKI+h6wBX5yi
BFgeMEp+9LshJE1ZlAHJyEhNadSyE+1xcphxn7eTesDWAZcxxWHcI/pomdXPU6CeUYs4+VbAv8n5
NsZx3jtF4vX7NvXIjOCdJ9Gw8DGVIMfIYLoG8GuvcdqU9+Xk5zQZg6iFMKeAze3hhnTfUCoE0y4U
WXuQA17jDeqRzn8gbCt8DEI931WNW38elkk/FE6PNhA1QGw3q+37T3PjXpgtSFhfMzW37xc1DsO2
S31e/dqnHZrNubTn/2LvTJbjRrIs+itttQcNcHdMi+pFBGLiIE7BcQMjKRLzPOPr+0BSZknKzlTl
ohdtVmaVZZbFIiMCAYc/f+/ec4li1/MlXB4xRTllE2hnVULOgyWeMzPuWp6XCe1K3DFtGF9hliF7
Jos741qfyxCMh+Vq1VY6AqofV6K8KeCEoW7TQ5PuYj6mH241oy1Mm0Ll69AhRrrpZG9jeZmKa9H2
CWA93yW+LhysyaTpEpYPDtOjAZ2IQcOzIsX6Pi1ykaxdpGT2Opzk9KGaWpoekdEF9JY888WeQTno
uBKjgetZNbNvMCB2Up0B7NGBeYYs7am27FNj1OhYIfTOL412Ib+j30mvXdmZ1jprU2kRGSXpSvoz
IdjrsTX6M+bG5P9OYehfj2xxLc/aTr+oF1sww0kfrzj3pkTtnbif4kGX+lq3e+u90sWwS8u6ebck
mr9VOqXxxHTW7277Lp1tWGUtDCacpmPDRMcv3NXUDBrkuYxYGSZy5XpigHrjy0hdqgpiwmYea3YW
J0wP07yMypbkWY01ZtTPk4UOl2wgRV6Z8FuCd0Qh3maduHDI37j2ShS198WUA8ue60i7LIsJPgha
lvBdUchfUgbor0om0F4z/na4koLbwSt9pb8ajTKuSrR271R4CpJnYLZ3ml8BZmRI3lyIgOTnTes4
5Iows5gR1swKt0frwwyFgs+gQQzleVfbjIW7Iexf58wZKq8TA4uskVNywB3hoP6xW8q/xFFk3rRu
C66lMrpDHvSCZC3hJzccM+d5ZQG+uNXS0aqRBc/FvBlqPaF8Ai0DLAqvWe6VZZ8BUJWiAm42uPGh
qUPdWEUNXY6Vg2J6WNu+41ylNk84hOaFVW5mRKXHmBl6ugYtw4CSOQ+AH78xrsKhmjWoQagvV2E9
zGpFk5QZjpDTFylj09y1FRSgWqVTtau0iumNyhqjOiILxdQfEwTaIQspw2jDV9UQ9owOFTNI0gjJ
HsrogXK2hJyJ9gUdSBsu7NggaaLMM4uG3COltM7c1B1dypVJ/zggFKtWFYWH5rTrMWzGewbb5YKs
svwqC9eJSDIYVO5gIQaXufnUOi1CaOYtDdnyMYUYMAgWAFdfe9WR/ivUAEN210Fov05bgxzJEb1V
4+n4la7ggRtEmdJ8QjGUMxCqp26uNzVhS2hqwjEstnoyozORVVJqnDsT2OqD2xcXjmIE7kl0hm8V
sGieGaLKYspl+vqreLBnwe7uEhXkUBszLe27ed2XSn0uogCEeoWknrR6hzJq01ioypllMgdcqVEk
xla1EkHSNDfE/ckgLifAgpV9Qz3XoRCo8uiu54xA+pDTyIMqMshOIhgn5PYzQvS66etzzdRhPMem
DerVtIrw3cLWftkzY33UZT3ecdWy9yoqK6JyYn8mghN59evchPVN4Pqo4vwwpA6G5uY+IwgHMYmr
piFxaZLuJ85AuBRcC7GFR0df9LhYRntiaDlmjefLVje8WG/yu76fsqOOWBXAkF7Z9yCl0s+jLzKL
gWRQMalzeAgjbDJTCFuMz5HyDHyOiGfThehqvPfoZezbEueFsSq1CuS4qUUpqmxU2M9GraA9EnxQ
lTiDzGWuZaTua4rfFuZH2gvODnE33rG+dOIatBxsDUpGE2/L3LxYEhDKWnKG4xGb9Gm0raohPpc1
0inSC8aJebcWTy9lNyAoG+a4e2KSUT/aIcRaeCpi+oy2DIVwmEPMy0HMnmlSTEczLgcyixD7F2dt
q8X2Ju8D57PD4O9UKqZB7Eaie+7MiTA24Qf+udYk6SUQGHlUbjlcQiIkocKw4+oqDFo2OCnQLG5a
TqP7UJnZhxto4FVgjTMLNOtifGD8gbQ+yme4ZbXMGUiVfSPfOu4ETiMRidUrWxfBSxQk2qXGEO1z
jTiRtPIup6Dts5gvDBqNCdsjyqjdhno4MjSyj328rMws1sIPh0Pr7Qh2MDxtJjwtlOIDMq/GdZAi
Tm2RCXiXGXK6XJvy6xgmI2z2RS1C6B2DpHU2FO4hr/z8NXEmEFaOZVWogs0CzGaiY8ZASlIYwI5z
H2JMqNn5m5l0ibEWVu1QMVktmTKkM1CHmE09vfg2CSgrzQncR6kB7mbjZDq1qU1mPnyfQvElRiVq
t8GmiEDMCeMRCxLhXb7vvA2pD8e+SuE/rWMw/qdmWbdEWfhT8WimA/EfcUnS9opdsiNmDfAdifcI
ltmBEYaQc+U4xl05A6KMi3hC3s57SryiltpTaQ/Nu1sRxY5oK+lIsUjHEr2Znl2GVT09zY2b3dmy
wCggMMZ9+HVVQ2Ee8/ZNtm3w3sERAiaYzzkBKYEWJTAFh+pj4pKG4Ncsu2D/stgya6FuB4NjzbrO
i2APi4BgG8ee+mfbcpkkA46KERoH9NqxUKBv0h1kHTx1gNZvra6xA8+PXXne5kvMiEW5bay1iRkf
m5d0h1PobJjtMC0jtQgRYTM4zSHwwSYqFEZXNveJGX/GGDAtCihkIu1s4vFgIdlejW7ulm5n3K0q
Q2N7RsTPIU5WJakIvd8g5Yfz6if7Gq3dsMXUmc73CQbLxputTIfGNCTkAC4cqnebE861bkfju6aV
ELNTE2kXMi0DbXuUB3rJK6txXiGSqdJ11VsKcijBw8/kh9gvKm4qhnpWx3S/QflteUAiSfwIyowk
Dea4FWEpnGB4W3abZhguybQpzyO3kRdWVvp3KvaHXB5bA1KUuLODVp9RC/du3aFsHJ3QOc6Inepr
ehAhgpE4b+ONzU8f7GrWD2ESBnDm9Lp6nRMFGBtgehOc91HDhgiLvcJYkUYg8BByj/Bokbes+wne
16qsCzWeqri0oo1ltVga8wBR8Qq9bfxmCQyMbMAWKiBEnHhRiGjhv90eI+bKjUb9Qium6l7TK50N
vZyKe32c1W3cZI6JsGBZqCBro4eR4AtkEnoxnfdxPX6gPRaf2zhnoxMT2iD0UiNZbiWUcmsVxnHK
oN42ITSmxhD3iH2rzl1n+AKuWhletZqhqLmzsL5KJ8lYOug6N9xBzlKPY6eZmOJGG9EdXlpSOgO2
G5Nz/BQq1IgJggoZdWl+COzUqh4NQLL6uTtjaNogrCMGoG2YYW0m2+CbWok6zZGGsL/OPDuU0CMd
45s98GhJsUZKzoS+E59nce73qMZQJDiHXg/7uluZDkP8nQPmd5zYsocUy+YUOB95yq63iMCKloNn
6JwO5eDWR9w2XfEJYAQBXmY6pvQ2dS1oWgLnHLM7oiQdS3xLmGbIwkjoA5Kz3qruOh/xLZ2Vox22
5/WUgZv0NCt3mkvaRg1Gt4nMmgLRGVLc+KpubZh+si3z4Zk4ESv9FCDn7aGUCV/aOxXCUvCMjsu3
6XzAe5uBRQvXC4t34JA0meP7xA6X5nN0XTato++ICLTdbYd4geNlO7kuM6nWZ94P/VGVepWdG+Xc
o+/Dzu6Pvddblc2hBlNfgSMvCKORDwrOPibD1CXFR34eO/6VbJ6IqgLicYhVZ+soGFkco+XowpNI
tBpg3rwcQXQ0Ae+h0OsL2QMuee+qPJ83Rjdo5lsokPnspg7U+mYswOGwO8DahverbA7ffIqcZg2K
djwvIAs4JdzxOEQgCl1MTW2ya5Mu7CWUOJ6liO9lYmafnaGPbLqfU06zsDWL7B3KmyNrLx4zyz4z
8LamZ/h2Y64a+k0GSDFSrvItshtDEmjZR7DURh4z1fnoBNVwNPvCtNBUFAwCrrpc6TY9M5FCZQd9
G0hyiIpYg1Y5aCqPbtm3muSeDBVLrJPQmkNP5WYV3xEDIIqdL1FenCWYT6ObMR4n8gGAxSx6+M53
zsgYmUfOk13XAFSbfIYBHrk9hUAQK1RhSVSzGKkJbV78X3tZkL92SJi1iLWZ0Xt9zKCu3jDzKaQA
fUBGSbQLzDpOxsNkNNgQN21vjYGzizqjxUIC+jaQNI8TID0+TWUOTAR6Sb1p9QpKrMXDdjXiNq3P
B7uWbMrk+lTWkn4Uds28wZ/JWPrrzOr/Qjzw/zaz3BDMKf5cRnD6zrl5+kFIsPzCNyGBONGJAZfM
P6VFoBqeg9+FBOIEn8syA0aExJR0QR990xEo9wSb3iIjQAkCwmBBgnxTEfAjYxmRIzCw+T1mUn8H
3LW8se8mLqaylevwEu6CLdAdXf40pY39DrlXzdO/ZlojVrNWNAIWeVFuJlrjgJ2LPHnCltbtmWbP
tAVatOwUB7h69WEYPzfJAKq+JuUNf2By9IcuY9vp4vyh1sk3joHUPKnEta8Y4IvHxhisj6HSXhQy
qrcvF/3/4k4s3/Pbtn5/by9eyv8PKZ2Cr/8v7r+X/L8uXqb3/MdbkN/5dgvaJ3DZTNgb6DcAxziC
ae83LYt7siDjmAAaiB/QZy1jzW/3oG1woyFWgcLj2kwnuNF+uwdt/cQRNjf011vzb6R0fgGd/Gvi
ZyoOdcz5Fu6YqRssk0UL8h2BJVK0ayoNvV3G/MAitW4KDnFvqG2DDG0fpj5VbNDT6oTXWnefqsDs
mJXNYCRXxOoE6R5NHIavgN2WcOXKRAIetkM2s1mSJoT7x40eepOOHLBZe3hO6WMSQt/6FJ5jrBPa
Ql+fyiYWASZ0afYtR9xZX5W0Ja9wKY4fxlmFzRONPC1Z+swuBTjAViapFaOIMn+J53ZGOunH3W0L
26S1JxqvSdTodwMqaqyakZudDZo+156EO7BtZiyrK5DgAzyjugmZE5jxmxiIKzMhDaxjMQan5ahG
BIBW2d2D+TIyzDNVtWsYuGxN5uDpLnfbo5tHWbpNbbwmgTNf2A323lWFmg2T1TDruxlI44uoDaoD
5uHI5rGwvoxl3D7nTl/ui4GOjdkiyP3POmynw+d//gO1xF+tw/OXto9efliEyy98XYTCOREw2SzU
A8AKueV/X4NCP3FBw4GA4jAPvXFhXn1bgqZzgqzFMlxhoVI1kZr9vgRN88TCp4vtgQ3E4Nn997Rk
X9bZv9bh4g4CvsRewD/S5pV+kh0kNIJyG1oHEz8z/8jc1n3KMzyvHpPOXQrT4j3Je1w/mKWcJ5/g
qm7jTN14sSAgSIPHDH1v4WAm7NnQaojkMb6dzQQqYBfPJWLz2rEJQaFnZ5O/hz+HNrNiyub52Cqe
fMMyGU+zAAhzGDvbWNddj04psxOOuATQYNcnGbPYGiahUGeyRaNOwHqYHLlqdGYxe4xvoypqbZeZ
qm1Xc+kg6Q+Iy8RfxdQ9hWBFyMMKq2JFhlYVGdskVDoo19EH3uJnafwoUwc0vrIWWn4zLYd7KUNp
rmSvyZeU+nKE92opTCGFqvW9GBLtFOXtRF9jmK96188/MOpqpwl6YpLYqvHGTuf62jcTTuw6NNVx
m5E5/ALX3OkeJqPDIkjD0AVJnk2fTDHRUcFAMd1PE82BzYj39MAkOcqIM3MIjsyh9KDipSe7rQh4
eGRyXIakT+XlC52H2lrBZIBTkUj6BR7Pbsr7sNfAuzhQHj7XzHGDNSIOOneEA5oXdmdhaK4qojg9
NPfdB0Eb0X1A9dvDH8Yyvs4bkIWII4IwXaX6oF0YGM7mUwzuwR2TslpiOB7mhz4iqgQVQWhi4XCa
OfOigGEN7tsmuG/1mFZSnRVutavRmFTwZq2aCsEqhvY0wkHS4udgm9ig3FrSLWjVkr2AdetARxGt
etDHxmdOo/JUllrmrAaDiJR13ycE5KVlKHaV4OPw9UpmEKQFj+aW41F3OmWiK0HxdDDqE6baam2I
DMZH29iEZOAoKmvk2p1BkKBTuauRgplEKtF7XaFN9gakTaavJlXB79AZtp13WFNzLypy3kNvV0DR
UXdMr1Iz80dFygb3DF2zV05oKaZM1QK07JQi7qXF/Oqv287nVqqnaIb9AL7wvEbWGHph1FTXSrMJ
FzBmPV/DEkk+Dz7j3DX7lHWXLZa9TeKQQcFXFcTJhgk3IirHcB+ZV9FkwtZssVPYy1dfMNuHn+x2
dcX5rNMe1FQlFsPOLvjQnWSYdjnlmeXBj4mSy1FPdIKdCN0lt3cspx3ablhNhi8kaGdRh/f+HLiM
C+ik1CRdlvgs41bO9yUU6IjMGOI61y2m4pKeeU0SSYh3JtxqCSk06wzHMVtpPOBexw0Tg2Uaam0F
mKV9HvGlPvjgnH1PGvMimyBoormQTtLT+NIbhzzqWA+z0wLFhzoEAVFDB8Z6GWjJNFbOGqCy2e5w
TkXx5TRonU5+hjFjBGxmvnMD/R9BSbVfgWJKXZJKJwSXg1dXEMp2mkNJsS5dF3p/RcjYeIrN0D9i
BmYl6zNEdy8qo/7aqZ3COI00BUx5rMlLuB3pRhvPjSNiY4N1SuHhTY2x9Kp6bh7pIJoK+srQY+2u
JZgUMcUAkCh9JoxzpRWD26Ydwxd0GSVod69xZ3NcC32UFB6qGXc478AywY7vyc34lDDx/mgtFN8r
2l69y6NnmdPKKJHNrrdm/R7pseuQUVfGbwRt2+12AGArSLUsZPCqtF49408LPvcY62kb05vbhHmn
8Ex2/eKYR0l5n7dLeAdj+3JTW4ZGPJVQyQNRfFa7MglqdNFIWMGDnYmmOu8AUNMTL832gSFnCqJJ
1Yq+AyOSlMNrATHfNGOHJClEF7D0fWEF12LKNujdynyTwetivJ1xXu4HthMolUPXeaVjzvAW8kge
Z+yTBBfpRld4qW5rFVOAvk5IDtH90xZHNbOpdGoeKpU2r3JAMrIhHrOxV4B5NXD9hipIU2jpn61q
s3Mcj3zKziBo1CqiLToNIDtdasQHTdfsD4rOcckM8ukHUG7K6eDjjZUbk85sAJIHjg63UwI1wlGV
vXHcHnqYU5YZoKtwXJrZoTW0exATzmPEBmDsGCIYr7VOUBsPj9jSvZrxOvSR2W/nfRghVSMmsWzf
mhojzmpsq/moGb5/bGzHafaZ4zxpNoMBIvLieUd8p3U6+/WAfa4IzjrLZTJHmr1P/5W5DZk5xbFW
TnuBry37WIzazo6opWnfatDmGDYtrITYLD9GDR89TT/dZjMZmK1ASp/ZyQaiXBloE0r5zOPbthjX
W/EjvVBjOGqx4dzMjtU+OJXRkHcYjd2VrRRwq2T2h4cEnzwEI9WRJsUXZO5sTMoNveYpPWDzrCCC
gfBiKldZ1rzK7XikG5NMQnicN8A+GW2/U3Vq3hZodgMv65PC34Qm7hxcW1TqTOx196mnHWlj+PLD
l6TpsGoVZaynIE5cRGiOT2uSydwoFQ3XeP7g8/T1ma8hvd9NMfOpc39BR3kTwjn68fgtL8M6nIIN
LVSEHCgKxTPlXp97s8KjssximVmYWhiS38zgy1r/pyj+WhSLpWXw54fTY9e/pN33RfGXX/h2MqXx
wNkUqb9uS6Gwwf9eFUOEPtE5fppUcChT7QVW+ZvJgtIX3Pjiv4A4vpxZqZi/dUc0Qz+x0Y9y0mU8
pmNb+FvdEc7M33dHQG9TLSlX58FHqwazxY+n02ah0Jo88u66FGsvzWyLRD9/hDrQqX3UNc4hb8Zs
Z8GFuRLQ/E5V6ZfbdLLmq0aO/VlH/Db6nnwXBLSoHZwU567bVkfDGCHd5fjkLZ43e/iI81lEBZB6
JRzf8yrcJ6I1/frrXfinqu8fPw6Ab5DvIC6++Cp0RMZLM+i7w7a+TFvR4KlbRnSBF2S5Q9HtvOmE
HB6++5Kvvh4cvrdw8L19d+G+vRJQ9qV94AqeTj++UpeBDRnKzrwVWWpuQiSzB/ys0S438cRWbmhd
lF05MZpKjfkXovP/5UPyijCwUVJzcPpZ2k6UdzGCePBvzciFc0Zex1nqK3UemNa0+etP+YeX4iZz
FosYkmWu5s/XM+a+4bSQVUcw6e02nKyXzCIOThsN8xff3NIL/PGCSpqH6IlZEBxysPv8eEHtQrcQ
2U3VkQPUFlzBAczq1pnb8xypeDVmWxqGwAvQp/BQVg+Vrl1zzMKofRb4L5n9rqib8LfveRxSG1/p
mPf7XkF+yrZZemt24d1oZmuZ2fu0bM5iBMl1H1y1Iel1nTB+ITlf3uy/DpvcHXLp+7A8reXgyY34
44dxxomyFqHSEXG1tkXoXqzBAopVxkB6HYFg2f719/SHuxH7noAsyRHahuxs/nTx4IDbCccWdaQD
au1mmj97FxDT2ZD5CMvHwb2GJWYSHPzLO+RH18DySWnSmoZi5dEApsn24ye143i0XLI+jp1tDRtE
Nb6Hlzv7xWoz/ngjOkJwUXFpKbwJ9vI2vlvYRmkw09BGcex8o9gz90/2KtHmXZLZ4Dmd1AMXSQBY
4BJhWjOYrJTgKOUiZMNrheRsJhw3Hveiq+hv/P6w/3eeA2qh4ArxtYuNceLHN1aOVdoVsR/cRX5A
gA45Kpe2oSHHKxH2Y1sVGwBhNxoHzeu/fmHxhytPo4u9Aa72F/Kw/OkeM9rZ0kPLrO9atZlrpENm
CGPEHvLrqpkeKNGPcToRuhLgip9S0Gjk5w2MnWDhYFQvO2RWsoEJaLwULVjVTrwHy5FGuuq1sGZP
Eak5lpyz9P4XN+tPxHfumYXe73DHWoJgSTI1frxmGgctFcz9dFeZ4sKHujukJfnO7qfGHZDvL+RT
tDaaekCO9uWi/aeFTuuOJfP7jeu9tC//9Z4z1Zs+vWTv//zHefT+FrbvedO+Rz+20Zff+1qsuCcW
JfwXtyV9bzogtKq/dtHdE8UshgYefnqKBRbi77WKsk+ETWeNcAROX/Rq/9XB40eQ+cj4RhhJpcMo
5u+UKuaPjwBbp03ImY1ihf4+tlDzpydNpw+sBkpuWtdZ7XXo+s7mVl2Sip7go2y7bWCm8hO04W7V
ouDcyJGUW5lPiafrnXW0kXN5Va66i7kg2hoABuCz4FVT0SNSj3otTAi7mWVe4lof8AtiV29J0cJ5
itSlfqAhx2kxdcQhKW1UQqjfIJXV8bApyckVqyrykeIGWUGbibuZmrvxxiz1wS10852GBSlaJcLG
5YN53LJNC9WEk28dJ1WX9K2X6Eg0anQFrjSNXotDyYIFfCDjSMbRrs3zcOsaebgjfdC+UVWnvL+/
Mo5Fxn9+nhdRfL0VRPNFQdj+979no969F8tt1/z8p5Z1+vvfav77y4+x8y136w//svly51537/V0
8950afvbAGb5f/67P/x2/x+hl/7zH29Fl7fLXwvoYH1frBvclX+1brrxPXul/xL84Ze+LhrrxKRB
zY1JkQ/lHoPKb4vGPIHPajL8pD4EcsQC+H3RmPqJwY2s7IVUT/G4YNS/1fdMPxVbis0yZCz15cDw
24f/thtx3f60HpZfdv5/VSKsGlYKa4WV7SwO0p/to1NphoHsArUSDW1j2Y1ExGV4kHBqIBEtCYsb
oUnswzgzrifQ2muTRJpNrKMZCQ2Uo30yZxssXfTDakfsaOU7965IX7Eqt7vZGAZPLhwSN2hfosx6
KW3/niTep3kElVxJe+uY0QeEiqM+5QgoQkTMRkiQp6hluW7z8zY03VN7Cm5szfms1ALOQyB9GOfK
JoEUBCbxvNYazTfR0IuQpAr912p0h6fWQCECvSK6RXQ1AR1B0TUHun3RGkgOLWsiiDaAYtjTJuWO
Qsoxlg182byZt04AMDiEvHqp+7q799Ggni+cWMQlQBEbMN5E8905uf8cZH17irb3OvQlQzSaNs7a
NftqF5tTctppqODxjyFm74xn2xUQnONxBxjkDSZMeuq2CN2yptiMhn+G7YSY8kA627zIXoF7yV3U
0n3MiQPZxgLLx9BY81aHuUBIe1qtKrSSa2LvwHdlps5Hcl6GRSfXD1HrUV62pyA1gzM0Nc8Iwuk3
2bV4LWhH05yvbXOveEyehTFiNBoPgsx0+y5ferc5RqkLqK3ausT/uI4lRRIjDdIpU0JiHe18iBpj
S/hL9WkoSFNDKk7DaJoGJGL5TahGE7uS23glorsVmLuL1Gxi3mhtrOootFa4ErM1ssV7OQnmJNUE
8LYiXg5a9Z1cNIkqoCzRO/Pe6oojlDBn7ZjkD2MbuC/LtoV+M12YA86SgXTBT8KPKqR9RNhxpdFQ
hWhUIm3aU28xzPBBd4VG/9AOiKCUqG5RgftI+/sLlE7o9PK82Og1krYItTLYva35RRXppC/E5tBY
M87NqlVQgDP8OFX4ae7B/ja+eNWnwNp0RB1AAi+2pdKfOpwFPMJB9mUhcjw8S2lLdmEQsBEA0n+t
e2I40TldakF+R3dpmxSQrcWIQK4xH0hj9rctSVBbuFAVuhdauDiS6nUtcrHJZFcfh5IEBRnaq9pX
OEZMJrr58GA1SqEy0LUDqvNxlTrwxVDxPdUyOJbAgW5NrSJGISDCQIbhjtOc5SHkPRWNs2eTJzfI
L61DUdlo1fmUxjYqWoCxKWOSpgRNpi/wfCeqn5oF5jigH8W7Yfv7uJuYa7T9Kbypcd+38qBzlN67
k9yVZk4mH/fXg97Wr62lJ56RF51XLF9CQCzA1gK9tI1651nvgjenr+56iZtytAJyWlPGAA3vaZW5
s7ujGWqtQ5v3mfbpp9JFZoibgTTBxj5LOoOeIiaE85EW7mmTCwCMhPegH8e/IZfecWFEzzwT6M07
3FnhKBCjWclD7dTpNlIJTKpmuJVm/BRFw6ady9njRCvpZdapR7Ya+GGDph7PRrFTDS3RYkG6ulkV
gr8DpQAwtv2EZpOwKaHWAM2ClYNVfm8Cwd5WpB6sMC8C38K1fDPZjXmEru3gPR1Sj64xAqWZp79n
GNNZJttDE4uapcbxJE7h94ikyTddH11TcJ2JfOCpokXGOn9BPT7eAPA9+LJErw+FyvMzZlnurNur
QbSf3GB6rf0h2WkcApy16UNrCwClViX/RPad6wLIQSrG7Rf4WGioQLrcfu2hVqZ9whItAovmcyW3
RIQ9pIObePkQ7nPwWpus0l/ngG85taE4M4/wAWCzOmsw0IXWIUC2NdMbBlr2rc/7WVjdez+y3yFn
6ajrkgVJ1F+MYvxcTNqIwjldyaEpDqRR2BvbByL2n8rlS/3zq8rFogL+84r/4iVtOcu+f/lTX4b7
y///a9FikKhIj4yj3G8j+d+KFn7CGR7xlaDcFzwfqEy+dSUl/UpHSCy9tCbpbiyhYN+KFmme0FfA
2G6Aj6DqIQTupyLlr4oWXooD4HdFi6DryTzTIkEIJBHNJ97E96d9fQgyDUsAQxpmlpFjb8SgvA6B
Y24hXy17tqOXVsorI32ZQ4RXd12xa0W8sqbwmgCxnYxLrMPnGWOaprkdfOzczb5mpKTEXiaARjNj
E1QFYSA8Bea9Y1zPAq6a+TiXF1bELI+XHsqjGHcA+tb9mVa+FSHZdhtj2gd31nitpzu7ppamt49J
bswPLSZn3DaFWHSZPqnK+xkwlVXuLGIuUvJrC/4nO9U9KzrgPmd2QjVRxRRV72kWezUYUr25Kols
b9W7Kq6Qr6MzrW97IpqT8mMezJXvPk4lhLesejX86bLVp4Mm2U1xww3BvjblRaIzStfq1Zg9Oskr
lec6KgIof9YKswCmUcsz0IgO7qYmAkVP3kRZnhfmre6LXdi/jLK4NwFWAiEjU4GyQcJlyvx7LAZb
owy2WRGeBRXBZZKYktE4cEzhIjKWM/ptEUgIW5GXkNxM0eAZ4wfupl2PNxkDc/SsqkOP7VYVT11w
FpL2YuL60xPoevWnLILAx4PHZ1I++G/sE9k0MgXap/q7Mb85jJHcF8Pq1m0tNwv2NJxel5kapu8r
hifHDkJkYu9Ncs0wwOz0hrrQftSj+TBpOIcxc2t4LjqzvfApqFKgFkW4CfFELaL3HEX/nOxId78k
tgcoJpEu6BgSaay7UO6+8OysblOX/cYey08YNRHre4agqkgH2r4NKltGTuzoYfUC2mRNAtVqiNRa
Pxv68DQKG+QhuFGIeuyn6KzUBZXSrazQZn1mtLYmf4Xg+cFT7WF01Kqun/URSAPCwtxEeAvClLxe
vl9JdAL3t5lCHgzWFka+nD8laZNazU4rdG90850aMOdn/ZlNQZ77ChQ9Qi7nkg7/WtqIZHG4i/Q0
sO77/qnEW5WlF2nj80F5D6yE5RUD89noqDhxkmf5UzIxcx65U+Uhjt4IotiU9eTBXPcqVptT4lao
Zq/HsTKHyK98ZL9K2+Jr2CKs2ec4MzLA10OALsMYvQjaXS7fsiTa59mAhiufgKYRNBBO22o0cA6O
nrLFOrWJseCD6+e9cVsm42Xmfz3s/umxaGlK/PEBY+okunIyQyC99Bq+aycu3VQISJw2RPoRwUdv
sruEnIjBz7bW4M3iKpCcaTSC6WvnXFXxYbKJbenDDbEyW80fCP71t6NVbnsCs3s200BdZX64JY6T
X2P8brzm483MNI/cGdTm5D3zO0a1NgBYK8iWSH1wBa7qxF2J/qwIb+ZqS9AFk/9wPVGCKTI/bPk8
RSshR7oB965WbASreeEv9g5rnG12PrfU5xCpQpxrZ1ZzVmUMlptDHL6g4G7wifVUCMMx5U0g76fK
tjhFXDbhTdZCzx13320v/0sn1FgaMH94an93UX9qQnf2hPJnOcLN6Z3eJleqiGHBY0kbk1WWPxPT
gpr9EYb47OyMJcCzyn7xvX7ptv78FhD6WqTYKkGn6qeeaN5rmvONqG9vSNFeIcxa4jSaK7BJsfUK
dYgMupm5q1lvdConcaOsQ649VvZh9DcJJFqeS+Jej85Z9dp0GM0z5Omp60HmW+nWviTrQusu//rK
LRfmp3e90H24F5d3TiP/x7vR4I6JEJh1uBpeu5bSUYf+b59PyfyL6/PjmIB9m2kiLwMQiXEfffSf
v6GgI4p8gIjMKiOGz0nBpa6dcRc5+6D61WvZf/hYyF0ZClBH6JaCe6N+/FiDo4+aIB8NW/m5k1s3
tm8cQD7vaZLte6uHfryU8zCiY/k4lEhyTLkzzENSbEykSclwkeI/bTFYrJIpvlv0bkaSbuFiclLl
6BGAFGCfD7WFMpnt07y4jYOMFvd9yOLlkPxZq6mvS+JG0uoQ9TjFFzppV67K4NPQvBmKvpo5Xc14
DJ3hYrTq0/FS6deVAzubwNFguq5xd9qG6bnWx2Ri65DkkbIwkTPRAKxX/VSiqHHhVpbPfSYPhT6e
j/9D3nntRq5kXfqFhgCDZNDcZpJp5L2q6oYoJ3oGvXv6+agezJRS+iX09XQ3Ggc4qGKSDIbZe61v
5YBxBVPJOAXYUQ5G9JSzRe/j+lg1GK5i7RDlhHK9FNoNjuOzhiNb62wZFYABJr8brjg1GGotJRp+
IjjrsiC6wDE7KBH5MXFRoXQHp7xFzsOsXu04rW+Eg/uNx+B8H6JmN1bPmiT7Y/Yd1CVyfo4tG6fw
jAqQtlAM4d66rxz8WQkgDP1yRL0wzX+EfpG5tW8vIzr3hznlPJz/meEJ6QXhkfIMvgM5NS+u+OPw
CKByaqijxvIn8nrObzQ97tLimpDDXj9m3d3AymFDUKm15ygbfL1+XQEK9dz1hMZj9dJF4vfk3bTG
xYj/Ls2w+LWbQgH4cfsNRsf9Ys6+HVdbe1VJsGnrXOAIk9+qidlz3mgoJK32osYM2QBA7RbUHot5
xA//4ObdHsUw62cifWsY/dyxDhOJSi35T6mC2sqjQ8npsbQtPYVj5Mk1330uzhcRKFw3XnKIkYTl
9BdDAX6ZOITaRwMXmHwnymC+Z+3rm62MLqDNA5qLA4u9GZcrY5vjuYXEO9x4zRMxaeifOYzvS3Pf
xhiVoZSE9pMIo2Do64Nj36CfYyp3DuuSalL1LYgFqtjIaESl6lq5xa+Ep/lKJn/Q+t1OWRDmkm+m
2zP0sIHvsNm49JgNyR/ro4M5WXhs3O0gzwdM/tkcn8nUO2I/5ZhqbzIJPHxJqDFgy27vFkPe5+bj
IIdLLD+4re0zUQE9eXTjclO7Jo4kkvRiuui5n9EqLcK7jDtxtRtCcbaiv6373+PEgbgZtwOOPks/
G2a2BJC8RmdH2uYZIWnsYVLfQMYz0pt07cBVxl0JNy+vxqMowq1RvSj9YHd3VTNsUjJP+LZW3dJo
wWMmKdSLviXYr2Y99XPcwUBvjrF3w/ZvdP/iysQKyr7O2zoLS6R4qt3rXgpfLgfSEjl3s4gXHgu1
9iCT536CtaIfNdLavDG+z/CLLQSuiLKjEHMdksbnoJvs29+a4n1Z38be2sbglwgmPIvD6H7dUo5U
YHpvVXwN2MCHXVz9LtvnKquQzLJmZNeUi3dd/11P4keLjJul1bd2HQXs78z2oIWXrRdE7tPgsFI2
K673BS3+fpYUxRKHEJHtmj/LphtpD24UoigkZ4vCxqrqMFRvMJj6ePpACdyhqARj9ewYlxHTbDs8
ozPeWAnjEvFQZ8ExwPRVupM/G9+UftZqQYWGdR56qp9HCDwbGD8707gRhyzufYukkvip1uKzqGWO
VdmTN+LnQxfiJhIYC0BdkV87DhojqjtmuexrUl1k2QVwGTYDLYkizglHwqOVIzUM2+tauNvIng4p
mVm5fTQpMk4UDW2bz7j5EYEmp9Ry5G2h53/qSdQrX0r2SgRIbqSd+54OzxcWcJI+taiqF4V9/z6f
/oCspITRH6YCCfN8p2n2vpuXsxj7vqSCrcfNrdbe1dlyDA32vERO2g184OSQLCTSUEKNKA0aJfAW
cwrc8p6loQWKknf5gz6exw2jND8O7jk2HjGWrz+lU50vtJuMwo7DeYWiH0ZjfqkibUS2G0v+Hke5
dQWfrY4PgtGKQ3CeqoAe6KaW2o6BtIvZ1UYAw3vWoYyTLUWqAJ7PxnCe5XxfWBCX23y7ZOosdf/Q
312nPPrd5yzseyxuiLthfWydX+5yNngH3Bcoxy8REp2H3WOmH/qRbKVmnw2HQf9ObtAm6y7qBCky
cDlpXSN/nLAAjreN5icDqXT7KjyzugsTyHEG3+uQsytwxYVDFo3RFVsat4e21v1W+9tO30LOXux9
PEl5NDOYC86rTG5Serf1j6V8qtbrFPkVAMEfsEo2g6x/QL/bhsBQ0qdatb5LrZTd/a6dHhonAmrN
QYJB6+nTRk8NumH6tp+uCSKgttRvnYoUpMq50jh/d2O9W6iXkZP8w00O8HuI/6zPuzEN8mVncYbF
AahPD0IRYHc1ZN8H54cw8kfR2FtLvBQm28BlV6XKX9HQ+cQ4XXYAZmDIczCJDX/5MaE8z5ZdWBJ0
gdskOZqQe7QwQLm46am+WYUPxBmwExN4xkyEr9a7BZ/mpwsOddCPEwYzBLFEpxHywtGV8mY6+NDI
AenxjQIQr0MAcUNEV+WsYTIlybTo4DSJx8Wzbg0lAyzbfCzZPmuG3eR6mHW155qpflTDbuZ4FVf3
U3vR9/XGQcCfh9WFyO9bVuVOG2GMxIHnfONwf2WSzVLWj+FqS5+vWrM4atZIC8WiLJ69ANva1F3F
ge1YegFVCV7MdzAOm87zgpIKNk7ibaeXl14RQl1iIs56X4Yc5x9GOhMFJPGp6IMWhphiWFc2xrpJ
btf7d2fOR6BShFVubEAcitzRvkwfEoV5U62LXHa2UHf1uhHqDcmkkxbYOk4hwwcaSmDQtuD56Auy
VwY7Ch1i55KtyR1KZKH1Ul4acE/tGAY8S0w+yI02sJ5XhIF5hV/qh7hIzzrAfFk1+9nKfsnZyanz
oWTxVVvySNmcjIil5Rbq5JXGtxxTV+nCF+RFfmvkhxj1inRuJu+sWi3cULiTjHsxUXsT9WJpvkPJ
JzPknlBZXLakAhfLhcmJXwvTv4MO0G4gHLKo9nS3DjAad4XuXsXrLsXEXZ1Mj2ZF3rl1EHOxo0dB
bC6jR68ugU75KgRMCNI8659IF9r2bRrY0PhAv2HP8O10usrBe7hZcVl11wUJi/gQg2k9tU7lT+zu
V/Qwj1DEww3UJDL92Ej0f+CT+YOdn/WDOEZ2hCt65LjabKf6ZpmTAJToLrWXo8dGlOAct4oCxy7+
mKjc6YMQFygouvyg7bAzwCZlvEf0+2QqszoUAuYNu0+ekYuuatB2TMadfm5CIUCTuwEQsbPs74V7
33cIWeEru+U3RrMVbsWs78H10F/H3aHZlMtJ0At/tIQsxhr5qzNHZQXLQD01xrIrTd63elzKRw4F
RtXSIZM70vSYw3YN6M7c2ZfDZbFo36KGlpyFnS39Frnfiowt5Tjsx/nSnFSy8dr8mrSWK0Qvx6Wr
94kx7inCSSs/G9g6FWVy93qq+6+0Jv9fdtQdyrX/c136SjXjz/lNYXr9A/8pTJtYMlebJNVfx+Kk
ulrF/iNBsZDEYoEA3mogNjEwBv/fwvTq4yRGBYEI7XSH8jN/6P8UpiXOUEyh6AmZhOm1O/9VYfrt
gRadLqVorNKcZ1fRkngNR/+nauRaJUEHFT0kKxb1rU282I2tpAPA1ag4SuCbGP8zhv7HQtV6RP5/
lYH1irR1HZQzaORXvcBJnWoxnVk3GpJfSVoqHyER2nuyoNov1HUnHtX/XAYntgMpF0UpDrm3J3Wv
7LWa1Dbpz2HRPwMg0+4BRjXXKgGPB7VDGg9mN1J4rHW4VvhgOus+77AYbIa6XblXsd4l+6KWrumb
re0BfByVagOwitFvwJ08HLuh5ezn09QZJHM3BMHzxYVEoOiFuERYv3R+tAYOsavmGL1zqJ4+kBZC
GLYFuQ3TizEQcqj0TJEcN/UWIZ/QBNjwmKCyrghd6v/opHVTOx0JXvFJuhQ/ydVKH7w+pnWn2jSL
zse2HO+RyQ91UMeJ/tS5NEM3nSAiYuPYkL82Bb4LTuK2LIazcHSyexNILlCEcATq0xW6V9yo2cwL
zjFZ7BwWS1Cr8eKMRb11MmtbwzzPAxT/BPCJJI+Oc10lCsMEM482oy+g9Sep7hZRF1nb/1XmFaCE
sAH+AuvtpswStotFParzDPokeKAu5kklZD6ugT4c2P1/Pr0PanbvRzQ+zbUgxNCmWGOdVJ4GHVeQ
SFhfalw1ADw0qrCyqf3aKgkq4jjyxUhbxWWnA5pvx6VNtA436/QTigmgzhy0hn6+VHCE6io0CV+n
OMF7EyNFl2hNd8ZciBDFrNJrEBBFvgfXQ8YX9HJQdT0u6mPUeKC98ZzZQHJMi+1CnUwRcAoqRd8k
Yt9fxA85KRU7AMgHZDviJZsBQu3oS+e7RoNkudGrwbgbiK1dX2DksLFrW5Ni5dgco4Ewn+0owrWg
H6aKY3CuESQZplgWcwfU8cZ1lonGplezFSRlTHtqB9rpdGc8r/fBYTSkVtdpuZXO3JMhlUcJ22RF
7eq/foEekhtKefw//IsTUZw3C9L+pCOIXx+WIMbruE/yCXi7XnQHMFPii7QE421r7nWqQJeE2snk
aa96+7dTBfDPHiNLJPzVkP6Leg01XsnuSnpRS5IzDMy7fLXxQVeOHpRlRlSh11RzQJ3kIK0WQ8JX
mseFggFBUIJC/0bq+pjvc5HX38xwcWL670qndsCf8izogp8/MYOF4mQIIoSiakc4PDh6wzx5ZBEu
4KhcQpMlX1Egafnd50QR0Mvvp8Ej1bKbw5s8KQYbAp9O9TFcFnwESVbw9RIhWNDFiDl6+pSGyJGp
sZzSGVerxgq/KuqTriuId097xu5OeWUI3idi/965LYehGXCsHXx+S+8/KkeAFWftk2s/Q67v7J91
CYVIKVa/kV9xv5d05csgA4V0gLqnf/H0TrS76/t3EZhbBp1hLNmcwN9ei82v0/TTovkw2zXqCNlE
Ss2SAT3byraFWZUwjd9I6iN/6yVJzmH0I5zMzNV99Pldr03gt2sj1gRWYtSgrI4Umt/+kpn0OAJO
oziYx34JzFQ8L7W2zp4YKTfRlFqbVnjx7vOLvhL9314VdzvaZQw6glSG1f/+77PusB/UBXjWwBrm
Jt92hYURLO0qeoOh1lAPTon98yV2ty1IVLouQxZ7DdZlaV2gqcLJ2xu9hhgdIzEpZnEOn7DxFG3k
MEzUjRk1YIKgXFH66mEohBeI+4xmS1VGcSzvNfcOkzozW6xDpjaTKDc3bpgVXK0Xw3VtY4LmVGNm
wHIjr8QUqszkWcZMQCSoLLB1HH3Gu4c1k4NkRKAvqfcIAp4AYZRoNGYiwZHBhba6TOc+OVCes6Yg
1s3svgGVeF+kVHmLStJSZCpd9q2HopYg1dbBvqc36fDF0H63QAkUjGtEDYgZYmesk5fcxUtEDnCc
B3ibvb9AUdNDvYjknBSlkOKn9VUIwsfXg0lDBwnSn1wnj38+pYn1wDDsIicqgJa307gwTvH0apRT
kdkTKyXrL4bxu49X0PoRaKTp+zjwcU8m1HkiG0xEKg9MKJV8srHYzy2cP83KxofPB+9pEAKsHa61
SkFBnjiITNff8s/dFTA+VMa2JIADP15MXWLue/DuapP1ffdckSHe+wlRwxfAyar7JbYpf3TxGMPx
Gnrj5Ytfs04Vbz4lfg1eDjYBaF1BB717t3ZYGeT/BnywojvmnjFf0QdCHGDX+RnkJ7VVabb8maDO
MW9ShErijp1XZye+OYvoQjVJvS/hGH7xSsS7qYVfZmDdY8iBrJCnrjhNyHCsM6hwMBXCbN9mSty6
+JxX9zZ9ugD+/lJuRzTfC63evPixaA3EaIwNMFRD4sogWEuNXIF6GJKb2B2W4gj+JUswpGp5d55j
Z2/2nz/OD8YRL9ZGM2yDAuAM9fbdhlNN+s2Y0KkkaflQUaU85+PV73StVv/1IkBnz+axWKtWaG3y
vb2WHJnP244GHIhj8aur5+6QWlHxc44SceVaHZEE9mIfq6JfdkNruL9kXC9fbCU/+FLXMyLDhxfF
ZvLku1mgbdB4p0QCiMNKdpNuqYfeLtL9YlFV38gC3uMXmy3iq96N2NWhxl6ZCQJH3MnsIOpE6lEb
hXQUpiTZV0NJt7Zri7UxoVvAQ0o3KR4Jd+6uozDPiVOXGsTXtqoRoti8O4QVxWSsqF7H9qO+Viau
/WLeIcJFD12ZaPdSePnWtiHD9fD5ADnpz7N0s2pwGGb/LW0br9bJxkdhFlnnGsdXXQiaN1kIZSdM
sukpaM4kodLoQFWNRdmxBgQp5OttkIGR2VSUhf27tSKNaHkdCxGlydH4yhXkvNuXCUJajBUSA4iL
eJiTycmqIsLhqsGhLYgL+2xsmllD+xSO1yNZueiXGI03EnxHheJk1M5dvSJDOMzywtxNqUsNOQYB
srb8vfZiSgf0Mii1sYrI1kXdoolYG7dJ11RXmLnJDRmzkgjaSXSsjER8TX5RrORrq2jUoSphye50
akb5pvWqsn9kYZ4mv+/j+AHbVYWsgMsM38comeJLYpo5HCSETV+Fdj4+9OhJf5OEC5CdMF4dmpi3
6pcqw8JsWAFJIanRI7+3rTTmhJx23fUsvOU+NIbpbwm8or2UREdY/uBoHcNlSMHhFlGyml/g6DLp
mElzY62hEkvqDHdtWsc2uZRyOLSpzWF2CaPie0Ik/J/MnNq/QpahHuh6DEzAWfr8ZwxaRFEPLlnZ
UAt1K0MfH+u+69yZXjGYSm1PwlDV+UR4RV+cIT74cm1WPJ0PiDKPtE9etG3ZnlkBO0FTOlWXqjFa
H07suIEjDWNzYnfyxcBfp6OThYZ1lT0yRgzW2lMXa1cNZGnOhUZbUjb3zTjTAXCqcAfUMz5zgSsI
mv2OuVO50/6WndPvqO98ZXD96K6ZMNlVrDMH+5mTOTObS4M0ac0vQOAcFlEsNGW80pdd/4tUnfju
85v+6HLrmspXzzpGatTby7klTc/MIG+jIekelDApqmGJnK7oyttltAGrfH49YX6wAAH7wDVm8l/+
4WRylI2GHULjKceR12GusgYnUyR31PHkN0tOY4SjU0868piPw0GkBZ3AAsc2MOfXOJ4pdOw9gHft
HBwMRJ5OsRODmuZOVqAvOEy1eM3UodGv/1JZnuor0bltD3IJmcFITeCDN1euyrYpMjLpLW0NZIZ3
YGxD6SV3GVq7GDCsR7g39PjWwputU4aWxVKXCNqyhc5ILNoHISkzbcp8cq/HSGsfVe1af4kvKG47
DF8Q8xOy6iPCVdAgpiBS9hBxw9tcDVW8d7Rl+UOIhJZvJcvkldVrZFXk5pwGIpvg8PYiZcM8dvmk
UDumRrUh3Ty/FCMBPzs3yep+y/YNzom10N2g5rEs3tkwxuMPPB2aRiPY0n8gok5pJBhZR6kGJssv
vQ6h/k5z497Nczkh6GhT1GedXfV3CwlP9RZ1Z32nMiwnG6Nukx8VoCdyTWCCg7wy7eQSdR84bjAu
iBMd+EnXqsX+QHtiBbtFE1phmBplT4kMKpaDRAUuHQHWJDJuyLy3tK3dm/mFq5qmpy3paN+I2on/
1NKBHGpbun3FB1B9k8M4IjDRVfdXH6bC2vT2VB2aUJcvIkNzsEWyXNzMcWc/Vr3ybhqrx9OhOePT
7Jmwf0hcGEnnjjMWd9yiFiZfQ1sp3pUWgZwyaNekg+Zl4HM7DTsGBS6KlIlqnmNSbdpd0gkbzrC3
aC2s9tJ9SEsbedqSVtqlJXtydQD2INlPlKI/WqTE0dv2rOuHFNrqdeZImLVWXIqj5dI7Ayy7Vijh
iEf9z8+/p/ffL4IpAGj409iAYto4+X4TKleIBR1/8JTtY73SSBBQYLRiOm068d/B59d7//WCMmC6
EBy3KAWeYjKLGOVeqxWsvkWF1GAcw4e60YqnVhBQ8vml3t+avp6t0IRRkAcWdzI1gbfOpEoypqas
cZ8SN8+u3BHZQ9RgrKL+5n0xNb2/NfoJFB3h8NBAYD//9lGKwewdJVtkOhVBPW7RlGdlFKF9K21t
9/mtvS+PvPYu2CAiLUVE/1p8+ueEZSSRlin0NhCNQXMhhPDkZTm52pHkcVA9UJUeFyhAGaCqZDxn
C9vejllfR1/c8gcHGFz5PFydrghHy5OtnqksuVjp4OF2mWba+I0Yl8AgdQfxaAg/6sxzRmDmyzz3
fz9/Ah9dGVeBSYHQtIFxnmzLkTSIwvQgXyV5btx6UMWwuDgOWfVhuIPSPF/GBNF9cfZ5q2t83dm6
FhxBF8yKBZTj5DyiNe0oYYMxoibDHPcxjQPIXYSBou5xlc4urLGvif4G/uV1ycXnd/zBcGY0c6tc
n9/wui7++8qVLRqCiVAjOo71m6zwkTMhYDcozEjU+qqtvn9+QY4ajNiTDQ2NKMCmtsHQdk93UIY+
F0m21PgMEAwkO9Es+s8o69sRsQLU8cPgzZProxaPSt+b3FDsRCykfTs0Jr1hz1LjH5nN2J1mo1c/
F05X7Ta2dc3bufo6fZdawgqYkWRZbPPRgAwVRRgtHJL9fq1Rijj9KIBe5sRGoCVxO/RZbOwV7G+w
/q8ZVw2Vz9r+pjsGujzDnVjnRj1tTXYinn1ZsCGnRUzM37NCDdD7zH+g70E7pfNmrCzpbuYUbyNR
ibILbAAbI12osDsTtTlDie6jnHl5TPXDrAk10YYfqcgl1HRQYs1hGgx0d3+Mpe3SM4PJsB25/Y4b
ilntsOuqn44zTC0BkD3oUa3NZbNJTCB8m4nYQHDWldsqvzc1+0q0EpHV0pHSE3iJG6Zb3GlZT3/b
0B5y6GT4D8sprbdF3YX0CfoY9q9nkJBSxTMmjnZaUF40aHkh5+uNrdGjwKgPR03egbBOX9i0JmST
1lEU3Sep3qX+GIfVizsnobPN27xHJK/M8d7ukkwLJjh2KNCInSU5KM56YGxdjKolrYpE26bt2EQX
1ajrt0XoVb2vkU53GFubvKUwBzhLEkQW5/tlcIiCSDjPbnQ16c8lHREqlSDMsUyyuTgLa2gthBKZ
q0OOTB0adbVZ1c9TXo+/mXgorjpZ3vbbIp6qo1mxZeEQNTc0/thoNLgelfWHSQcrAXmeEwGEShX5
tUlKGSqBqiX2O+wq/paCzFnINYaxiKOI0tZG5xqFBqJGhRDVItOtDvQuorBKzxHZqDIS7llGROSN
RV6Ue2C1KDljmJrfpmRla+WJ5rHkR+EKf7VMItKEXlq3g9ks08EetelXEjUobV1NTL/1eJK/I4/P
aVNZmvfC3kw6Z25mKoUouneSwxreXp8llHSA+ylXvZjLMmHUp9JwIQ0jBg7f2CiqGnD+RE0u1vwd
a+d0XjFskkvo9AZuithKnzu3tH6LJcRxndYaU1FiT/T2oIM2oKeTWpKI7M5Ioh1MdmJjVpIc2Wke
tKCW+HV8i4RK7ovjWLelx6mWbb0i7ZCghmPrN7hn0SlnZfnAL8mVbyQxQQxCWybzKPTOAneTRq2B
k7VDbvH5hPR+zifCGr4xucsr+tU7WWDJv2vy3EXJkTQlRRC0PeuGc6zZkpIHRxpUpOJ9ptqvVtuP
pkETLQCVU6p1lnky7SP9kJNL4p6fs4GiGRcjz3IGa9qrDrGiJkUdOPXq1iJjK8Z8RE3+8xv/YGfh
mTTfXguZbDBOfoAD/LMjJIdvOpHlGVx+cRkRe4rVOf7x+ZU+eMQ6JytitdnD0Otb//0/i0xXwRp1
Jsv1vSJezx14zAORjNEfTS7NXlbS3A1zJL/YRry/PzahxM0KWj1QmJ2T+5tbt9N10gz9IlfLAexU
69tMqOdycPQvLvV+CedS1H048wIqoIT59gbnycz1eqA4ZSy6usxslN6Zo+lHUzOyC6fgibLvtvtv
wDa/WE7fr9/CZItkwfGhgQqU/u2V06SJRNroLkIpzzgkMzkzeNzNi9TJUIjyVL/4Wl573G9Xb4K8
KX0QG81GkXLc2wtKYpf03uo8X+vyCCfWnJBHPHTRTB867/46TYozgbRXe9m6+Wxc5cpeFZEaRgWt
AEnpu0ulASxpTWRNyoidxF9IAGrQvJXNF8eQD0YA9U5DuvRLwX+5Jw/HUYp5xXVCf8zS8dLLpBlY
s2z2lkcA6udD/KNLmWSDW6vhk+XlZIjHqezSYbFCXAs41bJCxC1pnQbGuybpzC+G2/upQ7wyugxI
1ewfTpPIyYDJl1mzPN8c8ygiCMYoD+CSCsGpWoPjTHYJalJ6aujCzUG/btGqfnUO+uiGOQTRUGI8
eO82jvQHCvCqeujDcSxeUEPGP1Q3kS5Q0Bq8/fzhfjB/rBgQw5Eepzy+57djDsWtadlwmRF+Q5vZ
QfisZ/Yj/II9hcj2mBix/iS7sP5ic/zBdakoM2WtVT3+wXp73SqSVj3Nhus3XqoCUAHpi+IAhIuy
iKBhRmO3T7qE2IXPb/eDR4ukhZPs2g8X7JPfXnayQ82uQwsOmJTC3Tszo5UtFzAIKB3dF/XMD6Yu
7hClFltXvGen8LUSKkhb8X0EYISBhpe6i8IEb3MwRDMWmrmzjqYcHWtjew1Zw//9nQKQBOzC+WOt
o7y9UycbYoHMIg4iUprvy6HtjxT0SVnKcRl8fqkP3iWHdZY7C6QdsR4nl8pcN0P7hAlSLLMSF6ZV
aXhRXJS8BWVj/BDEQgbEWoX/9cRgcHtAMinh0htYOTr/rn21LHNXmvRkRWs6L45eq2fdddOjCAf5
RY9kHY5vp+a3lzq5RXOsu3Q0aJAmESf8LdZsjSIPwqsvPov17zm9zmpQ5HlSCKcN+vaWKFb2sFfm
LEjLuLxwkZlflzS5LjSSErcOArPd56/ug46mIYBmUQ+A2CeNU4lIz4kL+ESWB95QQ3BWaeElELdZ
aqrAWazqKkya8R5upTftXNV3txm1w2f6ac0+pNeDThbsPdmTVI5ixGIpEYHFiFq5Imf1KEWoqS9e
+ms9/PQRkcEBGRXCHQjVk5ljSca89kg+D2bA8ZcxKVUl0tIof4zHKu6ua0pu2OdD+BlbyMheF4zs
Ml96p+gcX2sKsvAGjwDdfcQC+Y14WdH5nUqheBu1cn40eUWLw8za8B7nXvyj0Lz8Jl2EbM5QAg2P
xQKagI4QAcMbg2xDYwNxuZBfbAXeT1NUiFB4CkYduSWvyLN/dnXCKUzOQijV2yn5Hk2iuJnc7GcY
WsbDF+//g4FNnYAVwPNYz6Eovh1wwFycwtGyCEaMGndjAeEnMwf3BriPeUUle7lRej3e9ZyYriyF
YCWTSdhyvKPF5mSixDBfgtrpQoe+zee/7f20QqFzBUuww0QW+CoZ/OchLNWQe1WS4MkXTbmH5L3s
vGoh4mtIF2KDw+WYyCX+Ynh9sAnj8xOrDsJj94cA8u0DcZNhTicsFr4qSJ3z21wXh0TPl9p3Wgzj
O3Ls5qMJQcbc5aCdnQdJBuAfQ+9rb+UITPkWojkVlHAerZzAvNrBhWcmxb7o7cjbf/6IPhBucLYy
BBsVE9AG58qTX+uIKOoVNY7WobphdcQob5oaYrqfQjHH1hW2FhbluDiXZgqev+zNNrBKL73ikOj9
/fzXfDCW+DHUFxFh8z+x/vt/XhiLvJu5AuEVr6XYNaU2/CUFann+/CofTJEOO841m4eDpXkK1qw5
fFjdEsaBihZoWPkotGDJ5sR3nL7T2Dpw7P/8iq8//M2Us6raXIvKmosU55W6/O+NFXNlqLrB66b3
s4o4Qlf5A+Ho9SX66HCnqZhoYsRAWGqr5uhResMjEkmY3W3mNPdjHOkX3ZJk+0Rgtvz8t73br2LY
pq6JFJIOJq69k++3Tnt9qBtbBtbUuuSaDrkqNktJUkWg48URezXV+IfazLYfunKQBYIpG73K57/i
3afKr0ApDHianRVI4JNd5Bx1WlGowQ3UVI5o3+hhoqbu6Kpr2E4GkGgR4zH4/KLmB/cOWJb1C/EC
FdZTNU5nRKOmINkHfWu1VNQsC1gC5YYS06sJWz0g/jM1d1EemndGFsZ/UVi2v/kYxl8joCnqbqZL
TilMuXTTmBqktcR1KX0tcx7+NJReATSuF+KOpi4fXxyosdDyrLxxcVuGw+04WM0t+9gEpXg6E59Q
FgibCZAo3L1LGCHWxsmcfkkbSFeAKkbc5IOeO9sFjM1yHKwUWx3IMzy7mS1LmB2kOd6wWR7kGdFG
pv3FFuaDd+SZ0G1tPsN1V3r6jkhGqCuzaYLESSu/nIvmurNBtliWfp5rXbzjbO19NTDeTQlMppSh
OUgjnVsXmrdTwtxOcq5VRWQfp7aDooA8bqrJccYvBuD7/sq6aTJgXltgO9bl7O2F+tGuqkqQhZ24
prjsWV6BUctob6WNFdQuSR+p186ryx0/gewnzKCTePp8QH70hNkDrwx2tATy9EyDJMysCfshj5vE
CEo/yRwwIYzbaW5Ngmet+oB2OC6+uPV3pwy+vBU3TuGAVYBWwts7F+iC0GhObTCVpGuXBLH7ha4l
Rzsm/TzGvbAnCPsnHGD97L+93VVNhkyDdiQw+tOVMtYIoCHvuCXBwPS+G7SVtlk/1+Zm9tJi8cMW
x24jUpjHn1/33QLADa8DihmZ/3in9QCCcgtHAlUNCtFkVxOYzT0RNfpx6ApxPhZp/+vz671fZNcL
shXh8dpUgk4lE42lhV2xJG2QeAQ/+03Kfi8s0rBelRPuixNhwrDTBuJ0J8way7kDfbceJ9r0idFg
jv3897y+0bfLEb+HwAhKnDZyixXH++9ypDQgkiwqLZ7yGXys34SNiXG4JmwaYIIGPiaG+2xviHMV
vW+k+mDhxi4sA2BkHWIUtqz2XCc1NT9za9PMAiwqtIgcQoTsIMYWqK3Bydj9m3ykrW1oS/x3yREQ
nSHwTq9HNo0/NKsliToUhhZ4dt7AWogwzfj1pLMlzlRiLRdkV6TftR5JBtANZxh8N2zbx8wYZ2dD
NjTC8LxP7OuYhIEHho35zTSnDLTXWMdPupZNMB3bZcBOaAmFkTTS62OrcogJFbSpb1gr5NUyFtiF
BZ2sAww8LId2jT4zwHthYtisczX9CZsya4IR6e7eoEsBbRedMC75NKu95KHx2mTv5EkNgiYZYwWw
zpzrIxtlWFYJCQdHk8PBYzlCSFw9QIt5MEM9nwPCxuWNsstm9VX3zoH2LtiYUBbzy+w1xBBZdQJr
7/M3/+5YwEC0OREwi1MlRL3z9sVXEc2lMalU0GjzcECvRPweoSkHSfH+i8WVGgF/2ckoo8BH3Z5j
KA0y/eQoWlfKSmVkFEHG2bH7NhAa+z13S8gjQ7vK5LRRc35xVMUA3k/J9J09kmncl62WQ3iscv13
Klui/JDKKX2rlqF5EUYXar6ra8t8TjoV3nTqq86xWWWJZ7mmTyA/yrJAQd6kFcSixRkevK7BqtrY
s20BQV7wWosuK+/TXDeJT6o1KoLTxPHUx706PXqtDT9q1d67N02FWSuYpG3CPUX+0/i1Th7Ppnfw
6gx9W/XbQceEBVQ1JuKQZh9SKGvspbyQTdzUBw6+HvCvrP6Tk1Q/YWvtoY3kKB1vxTzrju/lBgSr
sbNQHkqv1+4V04EeOFGsLuh7Rmj6aq+tz8jVLrqtmVNmgkwrcEVHslA/gMnxYfadrXANFXFvb+Vo
OwdSXqJhl010ppl4ZMTmNhbDtkRbiPyT/uvozzknJ98mOB5QI3ZfOO9wcSkTl2N5gLYbGVtsPuJP
4sR18c2KBlP6U6dTG6awrB/tgXBxIAQyxe79vzk7rx23kXVtXxEB5nAqiZQ6utt2O8wJ4TTMmVUM
V/8/7H8fWJS2iNlrgIXB8oJLJKu++sIbbGZDuwz5md/kNLXuW1MUPcm8d78OPR0r/k4tMZ8RAK+M
vQkmB5kj05rC1ylqapQ4+gzPOhAP/XdA96ZkpGMkfzo9a9xPYxb24zEGoI0Rt4oSN37BrQmTirGY
dV8bQ+jt84hfhNd8hxSfiPoh/8zW7rIPreyH1zxytNxfSF/loU+9mZnhWOOPmSaDPOATrNB41qLs
y4iCpHnsBRZNB1uxkbcZsCfakwh2A/6UJhx+nfwXtl5u00H3LCXF2FKduvTYhQW6WWE9heSP/Mc6
wmaY0qNXZzP8OlTlskORmO2/jCBTN4CKieIOXGfrR5KN3vgEGZSJZxgb83MUOvPHrlHVby2QDny4
ZIQC16B7yTcL26DoYI1d9znTRqhEWib4UV3I6AmgqjM9A3aJftpQJhDzFHhF7apORr8jZ7Gi4r/q
YYd1XuLtTFvrq9cuytv81cDHjvZDKt2foFcz44Dd2PRNJML6fDvsXIkEC7UFYgsgGRJt/TzsGA2k
OhsrOJ9O4/BxQFvvbgrL3y70uld6CluIoysJzdLSW2aGTH64cc+Xi6ymnPLYQJ051LMImQ6bim5U
mox+BOaLQGyaAM5nfleCX9tQ3LpM4Sy6Nh74SGdpaKJXeXa1Tno/quybwp8XYXW3imdEVPP+VDY6
OKR+1L/lKSK0//n9Ui3Tjeank9OsZb6shmJENmPlK24BCq+qLT8DTwkpf9S/xM1gHW+vd+UhFz3/
pfPOWOvCZkEIcxRlxDVSltF8rG2DwsfGrt5Iu/7OCaVNk6/YguJcy6IQvDcAwzDQAwm0ytDxL8Jo
uadjpPRKv4iwWcO/TZEwHHdwcjQPaM9q91WE3xmygrLP31wnLpsTKDD7W5eZcEBvv4Uru5qykc7J
4i7jUNqff+pOLexyspPWdxQv/tLMSNt48QRAK8ExvK3GrVN05fJeWkrQxJllMjFbbeusk6WSOqbw
9bpKPzYN+AjAON4jCJxk4wNfdnUZzC1Td4YO5N7Qt8+fLaljZzDwIPSpYQ0UsbX8rub/ewjJ5X2a
AL2fN4kS9D2Ofm4Z5Qcj14BTdhbSWYw3DfSxbbQXbX1AN9hx64M9tUWg6r3lHm5/hSuFm7WAnkEZ
6Q7zmHdqxV9NI2GrtD+FKf246/IvMOiiD3VeTp/NOpmdnTJEw/cGGrkfK4b1CdhYf8pE2G+9sMtW
goWwPp8GQDSzsPVmCJcRTukkqBqZqGkczR7Poc+5amEimqieEh6abGo+xVon7INMUg0r1zor3oQx
a18jrs2FKF3UzwOA7V9pnaj3XH6MKUFn1ha4p0p+BR8dfjJDbd4IzlcOM+h1ygFQ7LSB1u2wKomS
0u7m3q+80XkQ4FrREE/kg1qXtZ+C5L+f56zYyA6XmnKVGy6GOzagDgpAc/26lAiwpNsz1MI4tzvo
Vtl+qVD732y8LWfiYh2a/VT1i6/ZWn8AGEWKssMC9aqEARtmdMvvbadHz243mKBunak9FU3dB3ls
NoiOkKU/hlpY/h/eMVNhYE3ETNdZ41i8gjrXcmv4XV47Hc1B1R7aOcYxx1DTR4wDfmvc3Bu5/mV4
osJjuk5/ixYKPb7zIwxmw/OinDUTJFjvcoG4bQI52d1T8iF8gu/Aw8ZJXP7G85dNcUvYhS9ML1F1
V0EjzW1bFOosfIYA6BrJfETXrabfhd6PRmtKi10gcHOmg9mrevyEdyN6F89QPMN/lExofzZ+z+XH
h5xB4c2VuPCX15GBXkKBSYAcfBcLOShkxAhj6IuTMrgAtjq0AspSlU9phsw8YgkIQjNA/n77R1zS
2uGXkougBIuBIviDVdT2PNl2k2INvtCMTkPmFbz/Xi9K72Fa/GD2c4uEMvJcHTqBtH7a1wbsbLGr
Jtd8dSK8jXeYySD5p7Zt+x2V/waNR61WxsNI9+L7pITw4G2ZtXcZpJPhhKtkklHxxvqWlsflYIMg
y3zPo+XOpAA21fmGkrQjkkg2SPUWVERxNS/em0zpSLAWMe1Jg85L4XWX0bv0KwTnDbCMQPN3cKXo
eC6O8XWfVHdOVxfoF6u1r+L7d7r9vi/jsA3oYRlFLnEFibLzH1n3yGTGhRh9i+SdmU8eI/RZAXUD
R/sR4sD4IkuEJAvwkL4u03bjoF9dngahqjt08TR7dejolqUjEDE03GKJrL1MjRZZPEc44WPhVHh8
dC0zbkCvuYV+HGggzDHSIlQ2stBLMjnqb6DgKb7JFzA/X72G2cIMgf9V+lxDtfvUlXMaPyYIMGsf
gKdCQYoYl72EtHS/1zh3KphoD7IidSm8e6/sy+xkx/gD8ZUHMe0yE6Kpj98gKizN1IzJTmqUtQgS
lx6ST8xa9TsjBIlwGMi7mztTSZQfJfZC+FeoDSnpWJoF+Nuwor2tDQpU6yJDtDCXMV9hFMB+p9ZC
BHzIhYXvCdTyQxo10UmfnQ5wt+EO/4hexF/bvEzp0MZq6O2qLJ67+9KQqCy2g1T/RHacZW9DaGZ3
DaVBs7MnUmJXz836OLme+ehIu/T2NLbVDQzdZWYGxgZmEh54HkCJdbYkp54WljQ54/aUPJYmZVte
dexvvdry43uvlVZBliyYSckC7OFCWW7Wv9KdAWsLVarh4NPNbkzUuutGRwVSb53Ub5QRBzY49XHx
rCkRLs7cAAJ9zRrHql9a1zbqHUL3XfyZXcjM4vbRu3LhMD+EokXKSO963UcGqQhbv9N7X8yJ8t2K
w/IAP6H5OcjuK0IxW5LDV3JUh7Ealm8kXWR+a3i8bEJV9OXSX4oMqMiogSfs1XBQnRT4OtbdAbL4
lXEf9n1dHDyugvYgiyrXgnHoZIEBtFVJlOFQlCXDsuGi17MBaSxrO/kisUB+kaC//8cO638VXrrc
Kw4pIvckw0Aa7uaqBed4yWADjMqYM4QMjNJeyEC0w/BQd4gjHG5/kiuLsRTxSAeZAcRztVk6rpVo
0lEv1bTGufdmtLFdp6geIuZqG0tdRj6uN/LfJfTR8bNX1VCZhxa9xXL2kQ4dfB0r0R8KXWgE1eyo
3vWsin4/GBCuS7QRocFujTEu81ga9WCllsk7BZK7/PlfB8MJPZ0JuTf7Fkn1LzAkzufRq9DtaOPa
8RUwuhIIuFVtsZ/fT/fZiTRocIK0AQQHgRvixPnCMUJHEvM0ar4Retm9iFT1GVfaLHuyilGtEefs
6vSow0QbdslA+rMrMV/4bGkZbB3E/t0/zHfjlzojhwusjLkwd7vaI1Qoavym8zbpxE46+CShcUcA
VyBzQ0ZuoIuj/jEhuTjNBRYWojJBqduhsH6ZSu9+q9opwiYc6N18n6BL+BGRcLpabunhCdHw2/7Y
9O3lbgylkDu6klF213VO/HZ7D158F14Pb4bhN9xrrMdWGx7kY2zqUTL7SxsOv4yqqO/avtMqPxuE
hg73oCAfKJVNdu61hYFn63gIUpNxG55/l6m0QiplU/VHfYjL+zHU237vwFwBUy+s7K2O7cUjgU59
599+5ItjxyODKgMMybx0MSo8XzmLIH/HWUeNl+dcba41wgZMtQCXn/zu9lIXx44ZDrBLHeW6hWB3
wY01I2BIJT5CYVci/ZiK4UvcMn/eoY6LjUQ72I+TSRGAAxu+AwgNH2+v/y7LtNr9aCUgWofgEa2Z
9UghSVTqp6jWfIsWVIo0DX7i+7BcRvmhhmXRyMi2PCCLbJ3yRBbK3hxKeqUozaTxidjOXqRoUMc7
GUbw1lRQ0gf66Xrqx1xmcpF3Mz8p/HwXkdU57RGYwTiocDSsKXrsxyZEnwe93s99VX+Y9cn6Jylj
2PDQ0LXXJnIj4BZt0W1s6veR3fqxTUAd6gJ6XSxtzj+xNWi1IUJL8z1XDPW9qmja786cyuoh18zw
E0JTVRSEljP/lKU3o50UGfRGPBWvD79tJudYdK2JRH7F9GUkDQz3bZnTQbr9da4cgQWqqoI/9zD+
uwDn1UkZTsbSlO8wpdjB7Z8XARrXHZ9ogtrD0dEUCMVeAzBkY+nLRIXjbi8Wnbwex7TVVQo6jE5J
WOx1JGFKZd5PU+K+waiu3uxI1UKyPHrNrkmTHECO89xauVbDXImj7ybkoz0k22TjqFx2ivhFACNp
DKNGyFZdBQTXiKrUVdmqBpO7j1Upp7uZ0KwfnDL1TtRn1X3P7XyYyzp79eSMfm+Xmpsv5kp0gDrP
oaFWJjitUb16Hg5Tm0lkExytBVIoKygJDpZ+DH6RgqgPDK/DX7WD0MfetLL5JEtcfE5xD+5zp0L7
q1CFjfsXAhqqC0YDb3sPZ7x9ub13LtI5dDwwcoJtCafAueii68JO3KJyTF9DF/O5gg6z59BqHwV6
uW95Xuc///N6aBo65BCkRWR0qxMF9x274wFWp9uYyCVHZhc+4MycfXciGU87LN8R5L+95JKTnB9i
NFfoDi0fwwDjsN6ilZXE0ZiZfivwL+o6D/ECtchQjjPwoccBfGLyl4b4OsIfmDf6M1e2I9cSyik0
kGEh2uspPJxkbN0r1/RlTBe3jfCURpCxbrWHLo2T0DeKqTzhvImz22DW92ki1PjBBKT67fZbuPKh
qZR5BejWQZBZTw+aTNQWOuymXwsIkz1E+B8dhXNOWpGrcj8mOu4Ht5e8PAKQ4ekkMCdBeusydZ+9
wTCbCGlqRl33EJNEecA2VHlobbz1gtuLXXk+GpvWogm5IB7eOa9/JYZZhdGjMRaLDragG93hBCHz
PHqakuI3WJB6A7S/Xs7hZS5dN+5jV7cAfZzfDJ4D3FYkTRSklqF89NB6vIcPMnUHbQit+xhA29Y2
Xkf59xVRqoORsGQbSNGeZb5InBDLLRwGMEWpnuIwyVAjaKpXFXUXqOl6te9csYkcfY9Tf5+eZVnb
QW+FAE+ao62WlXoZOmMauT4KmfozKaxXB/nYjN80Af5tV3u98dtUQwWxqrqiI4Ogn3bvMfzFtjIM
vYUKo6kvaH4k0U7anaEyyq6yO3T641dUePEhskvDqvcTijkfm9goP9mgApDeVDPxe0DycAjCKlp4
pGXc/egTVXwtRjwDd6o12w6pti1QnFM66OgTftbHpCL3foa23fyZixyp6UjEOEkAL8HAIB3FvV42
sM9smcT/xAkwAkamtcRvAPvGeu9NA535SmnJYNwuwqRKqedFPBzDIP69kz8i4PztMiaP5GFJevir
AL3/YZeIcF/MZNa4pjFwn6reyPax2Vd/srgFsJISzXEiDacx9TN8Xvn3VgnNAxAl5cVj3Bv74eSk
j5Mlo3k/JGV/56kkC36amR5CS4qR/qI6QC+jZKOFwHbs9i0kAa38sNERJNWsScOaZ2hp1g3CyJ4U
NYHYAfkXcwYlx5Vvl3QFQMJOayMd9R6lm59R+knnvdAbSYlgGri/RfQnH1v+7BVzVDRkPV0quMOW
JUVEjNnaRH3VGIjAAEkIZFXLP3bnkhOimNh9q5jC/ullRelCuesCZeuj6ptetDg8GMPUPECtxCEV
hAo+jnaqxf8SOTV08Ee71vdCjN4EsDxEN25CM71GnSRE+QgnbeerI1QtOqWlmp5CHZv6/aQBYNuR
8+DEWiB4hcqciX7r3qpwKN2Tc4wTyu9I9DAPifD0TRkU7pB2wdyGm9kA4rFMZCD8jiUixZEHZjzV
RR8h3q/ZESJbSuuAcJIjflwAdn7Pagg7fYDVjtJ6keRPAsQ2mmFi/jcNQ+s35gtuvodAQZ8NWv14
IDLK+JHWbfZPamWcXK0Y7Gkv0Ja3dzo6Gb+qCYlQGArSeWwqL/3Ji4N8bCmIH2xcgutYzDFGL3eZ
xCzDKwaZ59HD7CC/6MiLBapR1VgG0bZ0kcAEcKyO329H4mtL0YlnDLPMJRDXPF/KmqrKUHI1DkIg
tilZTOGdxrBLPlttthGFr8REBh8IeELrWfoCq2zCpRs923kfBQZzUs3H9DH8wEzVafa2I/ujTLOU
JhimCLef8ErwhzNM4kS6Dap4nXCjl6HQHE7ioJdR6avRrJ1QtTGeKT07DIdxcN/4ehcK23w+BLwd
LNZYdbHkPn+nDgrHZWQaISg63el+innsvyfqWLeICiip9+A2UXwqjBKdrxaW+bdehh1ZjtZiRNg3
YZh/cTobyBQGvuI5KyGxnSwUFhrkPOBjH/SoW7yUek1707wCL8uOgcWvhJFuFZT1CLBiigwVsZwE
pvAuTFAWxQo7Mx74uKrcoYc7faAJZbY7L9QNbOknS32Msxo7gynNTQwOYIcoIKuKMiDPYFcURSgr
UFJgZDjqqmbvjRQjIaHo1ArQWMVXO5tGlI8bxVEODCvwYaxV2ffMGaJM93Pkmpt9OtX1J4HbpDiO
SBPNATxfDZUOvOJ+1pWDjt+Y60TkdErxfmYulnQHhPa0gayvdAg7ESoRbQZaZpd1sV2icaqXz6EW
jXhOlUyvFsG9OfVpsA7TkcPp/W69EN2BGcdpINqRl/2a1Lx8ymtPFafbu0y/3N1kjvDSiYAUoeTn
q4/eWGOoqTILZiPWrT0O6MiRuzYuf5GFDkJu4S/VIrodiLjS7rpZKHtPZOGwzysXmya7HVSMkJuk
/1OWxgSLsR4Qt6biKvpk+mSEpvPgue1E9a1WyWGcZqySWvyaULcp961tYhkRWZgsImb976hUYiNj
uxg1OQwR2ddEIwhaJOirTS2WSWo6eEWAigiu4NpkIwE9x5I2TiL12mMaFtLeoBtX/6uO0RiTpk/F
LxhokXMwu6F4SZoENYKprtxTXS9A+dh1ZxuHohK9o9tf48rHsIF/AAJZqAsXaBgr64rECOs6AImg
4U0CYyABoP5D5MlXGZvfeEj188aSl3GGzBLNOaRaaIDT/jnfAJWLjoqo2zpQbYFUlVGF1WnMGrXy
67SjaYi/nF3udXpghW8qpQQVqxTjdCj1vrP23aQ37Q5p8vwzoLcSBcSht8MPdiNx3QlHMjaOdwo6
2cndtwTGQnGwR62p6cDYKoY7AGNfEggr/ZMxeTPz1LFqDx2aTPNHUcVG8kGPjQnKoemAXY8TOH+F
Mgp4C2GGKpMZ/YlEZH21wAgmsKK9cbrP9Lz+MQ8qcOM46pkUOm7PgEmVca4dsIkvnxNl7H8WWGqx
qaGloi+Sav1nKLBmfix5xR/tfOmfelpWdHc0w5yv1B+DvLdAWiKWAw7kuxgk7XwnHZInzwRjTYZQ
lP+2cawy0OKORHg7mspD13C+GdeGyhFNO1UBqDrHjBScXOD10oAy3JNYyG/1qI3DITYy0d7hCCRi
6Dk5WjNR4+Vv/Yx0z3EAzdrseo1YeNjYAXzg8+QbwhZqf7aB3i4zl9WtHSNNb8/SzQPTls5x6A0U
T/ryUOMIhS1TWzz0TtxvHMvL69uD1LxIm2vLP95qzbDGI4Y3gQ/ghJTADrEt6610chAMNZXq7ed7
h52cPyA7nOEF6B1ma5Sl5zu8LWbD7aWXBkaqx9i5RLpBQaOaHSZ3iPo7cmzw+0Ty62RNhAvkYWzr
rQJnWx712B4NhK0b/Z8+x03iURqtXjyPy+cGGkZVQQEoK+sJAipOwdw9pFbGhGAyzulFMQSEbEn2
roZl9cGTUf+ED8OE2R+DJm8HREtRDphEOn/6NldeCq+1fxt2gezl7Vdw5Yw7pEqkE/AzHHfdQBuh
jzqlOWWBNVbl/TSjJoeWKqA71faO9DSjjaJ8iRmrN05nDIAK3AjoGOuWphzyVsq6yQK9iGMNKSWt
7J68PJ83cqTLbYRBA6U/jHbGprQnz7+spUUDsvdWGkgkm55Sp60QLW27D1OrTxun5MpSTMCNBZbC
TAqG6vlS4GfpTVpjHnQgRY90H4HVd7b7Qv9J2SCzvBNdV6+P47g0sBh0MHRfZZyhHsGEdZMk6IvW
KgKFyl9iQVXGpwicgfc8yNH9E2pdeCcsMf0eBcmBED0YfzcVNjVkjqzqPlWtCYvS2U5PXo1a9XOY
ujPeVVZvvHhZLsjLBPC7Axunje/7vmlRQFC06I44YP0rdU9AHdQEMkS0s8SXxjIXcm0xM1SaGIT3
e9Xq2rep6gwbdhlN4MewszfdOC63rs05eh8GgxBl8Hj+3hulAuNb97wFVcF9Sw6e8D6FjqI8KHlL
/a+4ctiiPL/3G84/wIJPIS4xggSgsgZZYeehqd0wlEGqZB42xb2lH7u0sx4Koaj3MLKtU5FUJfL1
tvhjKtE07VsXS0PPKK2Th0vEzkJX9KktZ10g8LtIlHtFDhpbU7G8QxQl2ohxl4kD0RvVAUCkYDQo
GM7fEnGLxA3Y3wI7UwOEW4FFdeArrV7P9i2ynUcs5dqNU76khudvCXolFCQgYS6Bda1ZaMIgRE6o
q4J5rj2f4s/3KuzE3NTy5VR4zxVKens4Ger329Hs4igyFebKwFTB0iiB1hoPk01kqZFuCtrJfaPl
kMY718zMYJJG8/H2UhfvlaWY/1qOjWI5wXB1EhV3hDSGQ14w5Nr0WLZO5edG6AQ0mYqfoAHo2jjR
vIV+W8a8Zy+WVZ1lDKajYeGRnZ1/TZPY6bZdVQc9yqCf4rDoLBxJ4AjWXTMcC0tbVHjinj8nst8z
EC0DlNXcjTB00VUGamaRhGKkAeqMLHqFQCpyWSNVELcB9t3Kr1ST7h4Uhu1PFpwvemeD+YB9tmJA
KsSlWahgoya3rDcC70UAoK1rkZUABHQpVNZYsYmRFG5qswiwvp2eROvNB16ee6fl0aDyK/C12rgt
L/Y1e5oCftFz4Opih5+/fk3CkQmTpAtCjJxOuU7DE+pMeiyicX6yvAJvFYG+NRPEfENy43JnI2HE
rBfwD4k4WOTzlaUwzHZGRitIbJFpu5617yuLDJdMJQ03HvNyb7MYjG0OEF+adu/5YhxcZYJS3AVu
Zxg/QB1op65TK3yV9OHgQdK8G2FLbyx69QmBdaKDB+SGlOx80VYaDPBxywpcqqiDqsPQb2okrfI6
6zfC07WluDc8hjm0HUHtni9VZihDRrrXBYYa2zsh5A90+eRXs3Oi/zjfchj4IC23CFk7ZFlrpRRI
KXlRDzrZXqw499Mw9q9w4X/Gaez2QPaoPm5HpcsNClppuZ4IuwYSpquoBGVYgdbZM9fBH/KXE2Yx
vsKha+9ci/n0Th8Lo4Wnho2lMlnup9uLX55HuL3Q4FSyk0XUbpUIxWnn9cAPySW13D3GHPsvCNMX
9wqR4gWW5P9hOU69Brt2gYKtITE0LdpRakUezN1sPplzN+3GhuGaFTnZ9wG9Af/2412eClp3fEZg
ce+55WrXLKmXjGubx+tg3djCHu/VUgC6F6LeaZ2mPJSjsQWuWj7YecA3XCqUBdoCTgGi0flWxalT
HQEhcnmKyQ6iYix204CLc9biMUZJbNFzYYTbmVX+aNcy2njmy5PC8mwmxpeLxNzaYa12Js+tFytQ
K9OzD0rtIhnCBjt4DFc2ovm114ukCdWYTT8NsN35k0atow8Uz3kwjJp8LDMKpTAvUFuNC/cnGkoD
0MpNceULAAGQPiALFLcMhJnarwFdQIScWZmtPLCjoXqNFj3tI/YYdMFnR7+zsFg+9CiaMtgwx/wp
yVOBUbBn/XT1yNrP6Jj/uL3JLg8w8DY6LouSHIyCxSfyb4AZKK+oFGiDYi2tVi/lBBVVGCTrYN2R
qHK72Hc6Qzl4Vev+50/Ni0cIU4PBwBb3Vts7popwJ9xAAhX79i+yo61i6ZW4SxJ3yzTogmXlePB4
oGZQxNBPZl+dP6XV49pH5edgPeV4JyoV55mZ0vyyiHifcmkZ7S6thBsMqQFlxMLs3cu0/EteqlsY
m4uYxS9hD3iLbApJzfpGRxzIqQtLYk2uAhWq9PEzY/jkdeoifKwK09q4xi8+rwedbWEpApQhaVyj
Q/K0NIbIsEf84cbmIziSx8oDfaB0Tf2AUEH4Ylai/SkcXTnd3leXzwnimF6HTqXE9NZafthf82le
NlZJ6awGjagsZv+UKCZizx+cLPqRlfoWbvbachoQC1IWwhdH7Hy5BC1YvUprLejRlsPgONePWHQw
rhrotEpRK79uP95lRsrkAToxNwFS6UDEVnEy8Up1stGYDFQ6JS+mN6QfRGQnxyomH95NuWx2oWdT
waZZ8W2Ki3HfqfgWb1y/F0SMxQnKBOMAwGSpQtbhOqoVq8CTUQ06fAbLtw59aPtZrVPtGxwREHLe
YMXDgX5WbyLTXLoB5kxT/ciAEIdIjBbmL7rDofeb0NCw8G5UbNmxj2ninTpBv9l1ZWP3+xLl3gJV
6BC3qTKCuIULQ4ou/O13erlXGeYAi4APuPSB1+KZyML0udUNWlCBOJ/AVjnO2wQO7QOux+GJGVvq
J8huHXJ73IKtLOf/71sPixE46OTYjO8Az6xZiD1IAoFh1Yzfu6Hvo8q179NaVv9xfLesskjK8cXA
Sl18rBGdArON1Xlfavr8K3WSf8rRzp/7xFOeGAwxxI3bLTmgiwvn/y/KyAFmFJyCtbb94JrwEaQ5
7yPy+IaZoTS+V6Hb4MEe6Z+1Fjm1vIYPuQe6lnyqes/dzd5UPuPe2x7bRDYbgWF97b7/HpInMm/u
XJSjzk9qJuwstrxExTq+JM467w65vK8J/IRLv79s3GNa1t3GSXlv9K0+Ma1yRODJVqll34Ud/gpI
VhG2VRn2815JRnUXGoV3VDwt/2wMXvorbYBypDVSB51UxyO83/Kz0zTuXVhxuB1ZnOrZVR7R/3P2
plMWJ8QUQY4Vff5tjPDWiHI33rgetSt7EkgfB5yozO28dg1Lq25EAl4d963ZO4+28Y5dGvs/IQCr
u1bBgEqzWwdMaO7hCt/FQ9CamX3AzdXxHT1VPgPyJKfp062m4AVHgU/I9OqdFkfkIQaef8KymMCf
SGRfKR1dfE4m6X0Z5sq9r5JQUQ/IsWq4KiqCFp+J1IuyK2pV3I20Jxl+UqZjuKQq6gcFvcEvtZ0Y
L7TsErlrXbenoMWN4c/twLK+HJbfy+mm0KOCJn1fxeqqnQfD7rJp36Ce/zr31hxgOWDsehhn2DwM
yv72eheXw/uC0LTQB1hoCmvrsCG3ydZyoCNJljhfuPGVVxCp0VOUS/GziVRzB3QrPQJjSfxJcbpg
Fna98SPWmfTyGyg4FxjTkmqsKTV9Zk5Fp/ORYjqGcRkDcgk177Od6Z7cOltLG2J1tpbEihbYcg3B
FjjfEC3FMxxowqcxi3Sv9r2712VsPE9pLL9hYoS5QpU5dxw6/VgADN5l4zg1u9oIh9fbr/7Kp17E
zxaOHDC8izxAemhQVlHDKUecCI0Kt9jhm5Pejb0Z+0o7GxtFxDvnbP3oGoMFSm1IEqAWzh9dQVks
ZL0Z/4ywudMHQN/PFsrfjN3ghYqd24XgD3OlI8UXpUjtfQS+/oewYBXuzMUa0M+MtEV4JFSmnzJV
0EcpRYzoqJAq2rCNIGMFXGS2/+CKbb5G+ViwX6K6v7Ps3ho2ovO19wekkH1LQ5PwvMqjoK922EyO
3L6Fvnwm5LHMvkfD1HlH8oCguv29rtwGdIsBtMBtJIlap4lo+qdRWlUTxnrNuNfyOPOV0cFGo2mK
g14q30WUphvPeHEyaMGQkdqADEjAEQ86/2TNHAEZQ7cHR0HTfcBsEkagm0VIzOj1RhC/eLxlqaU5
bDFBoeRbUp6/Lp0mmoc5VFyW0jvlEWOPAaXycsIh1rKRXqtsf666fuOdXn0+6ikw4Vx4cIfOFw3x
jjaNDK80BsrND5Ak8aFrVXRzI7klO3ttKeTzFiAqYHw+4/lSbcr+H9HMAlMO88YY5yAWsfUKOSbd
OGiX1yGvEhk5FP2XTg8j4vOlarx/ENaFzlmE4XxPS4Tui8e7PWRzEn42wqzco4xS/2PLQn6ItQlc
G79pX9oFmilh71i/+kaaQYZay0akvTgzmLNDlgJwTReBG3uV0bR6MwBRzSp6iIb3idJv9KHzLgkO
zDCJ+tFGU/7KSwdm7Np4BpmMAdfcI4k9k51gJYo2iOOgEqQBCcGnZx/N3tb3vfZo7Nv3x+OUrgN7
lqQT+AWOSijw89VSEJ1dFNf7vuqwmZ+0rZvz2qNRpS+CILDbweCff2ToZFluwbE4xGk2foX7WuFV
Eo4fheNutX/XjS6uBwvhFZ4JKgAj21Vr3WWerprzXB1QvEEmdUibAkXy0fjJeTEeO4xanlG2kkrQ
KFbqq1nfb+zo5eyf3Rz8AB6TqMdoD5zNKjZUvRo6YYkxuu004xNILOVD2RbNafHwfJ6nMbkf0HuL
GdeNRXA76l5mcMvaC9pqmS2gM7I6t1S0Va/ZcFmHtK8q3zZFKo9wS7DOLqQRnhqVCuyefgSD1xjt
J+cYmsWA3zLgXPPfbC6bAJKNkz41c26+NRMN2l03o8gfocWIwCn0oI2gfSWSnv3i1eeKilKJWir8
A74z3SduI3kH/y2FDWuC3UF/+pM0i2bjPV1blHETB43CgU25HI+/wjc3Vz9g1V0BEUqdZ8gbzuep
bRHl0rL8rR7y+aEyhfm28XGWbGm9MdiWjH2Jq1B6VvEEgQcagkpRHeIGR/bviYdSK+lBFJbHedag
V4Yp8MtD3UrzLo+77J9utvrEh/c+ji9zGyKF5cJa+3T7Z13brrwDUhzqfk7m6gNUeQr2NCavkUPh
BPj5jb4rER/UM0N/zXBDB8PemEXg1nm98RmW17x+IYAXFk3HRZPIWoV+LU1UM5/yGsswo0fNUEVu
Bvyj9cWlCY4VbPPj9qNe+eyLfTof3UVi5QLL0eDwlcfgow9d1iCnMYPWmmUK/jEXqk84iH+hy7hl
F3Al9DHIQOqH7sMiNrIKfYM9z2YTsmhauZ2PkrMaZBPadEXebEmULn/V6n3a3KZLdgBFiH/Ot/Xg
sFAVRrzPgXIgEK5VxnforWxqpywfZr0Q6TglN0MpsACrhWrkYUJ3YA4bGgvAbJ5S+yhF2D0ObTeg
WzMqx0aps30YM0LdDaXon+xRLPz/qLB39Cbi3aDp6et//7xcMku/h9SF9vP546eTh6Se0JA1hAbw
LPQ+2yugGU5lG3YfgdcZ1PnVxqG+9sq5+SGVLYMVrrbzNSFI53qpJlQFQ1ce8ii3nxwlbjY6aBer
gNLBb4IJIx1JFlmtMtkihZ/ouft5AGePupR2qKgNj7ff38VxZBVCwCLDj0kCDa3zZ3FqvdNV6bj7
CrN04NbSOzKStJ9Ut2z2TTJsAoOvPdbC2mMngUUFBHS+4MxswNFHnQV1BYaNksfOL4AeY+R3eLwm
hxpthg8Ag7AjteYaQWU9Qqwrhh2h7w3MTDQ/d9zkmFZ6a/gKprF7OyegBFYi4jIYPTeZdo2BuvRu
qtX40fNEbvl5JYSzT1tV5j7epZ23UyKn3lK+uAg1vEvqEIQ6YClo5ro/b6CSX5Z14e5dS4GWpoNc
RT0HMqJfTrV+1JCZDAzrP2vdoRplkHjQG2DoQ6xa3vhfF5vKdGtC2NLdc3UjZNSMNo5jfWnMB1Bb
3mHsJm9nw33eCOTXPiTtIlTNDKbT1jrwFBNdo9RiWXOxGDu5qYPBBMbz0Zbw9UUw5fkQ66DZh/cX
o/DVFVorlNGNUnh7kj8w1tJzDm1llSeni8qNk33tNDBaWZycCXO81fNXOdiVgfLtBApfd/qP2oBr
WiXyCjWIRL3rG6Spbp++/8fZea7KjbTt+ogEyuGvpF69onP+I8avx8o519F/V5kN260WLdYwTADD
VFepwhPusDM1WI1Q8SjncpVss9cuGSdoYiXkqyqn+jdWff08IE+s4W1Vdz9vD7azPblLWMA/W9Tb
Sm3MUHXSLK8j5B61/kUz1t/CmOE62aNzX9FleE4Air7+epFq5dh4grMhp9peYuiXkWdYXlC7E8y2
BRf3HJhooGCs+VNM+iEu/yreogEJhICGLP0HSd+8/IKLleOfQRk2EOg7ARUvS2wqSJXbsSTxyZGp
jwslOQ0dFfqlc1q4vMI723M33aNUeKT4sbOfUI7j8/JzuMS3sBTkhaJ61JNI4ijGczkRV83DMP8o
E+cbYXV6cCSvwjomLyMrF9qFDq9Tbre/bgIHh45CJNytShVZ+qPtEOjm3jw9Z5B7fwpTqPdtb7iY
imijcTD23u6CCWniBSujkW1IaXLVDJMDgSWL8DO2kEd+blPoclXZ9R/HMps/4Pq7mP7tPf1HQuci
KmHKUDvZYcCPaX1vLr9eX2YMzIooqLrYWp9QjcnH7wDqEcEea2Xp6wCS64q8gOsV711M/aZgnrTh
f73XCcgoDcTQMEVENw5dRzon6kvkfogifYbT3NST9kRxslkC3FK8MmRVoeG10ZLoP0WpJp+yCcMJ
Snw2KtBqrabZNxeG6KmxayR6KTHmHQ3pjK2mkmkrD3GndMYTYmTTfZWq9ex3fVl+tiMLbe7VcKPi
oEd13S9idQh5pbweQT7P0uWGWNUo7etsQVKqW23UNZBR/G1HdfnYgncNe12UP1CgQXkcntPD3INP
yBpv/lgotlX5Rbw2R14eOweC9j2UasIN9EeuYDejiwBIv+hBGlXjV9HOtnwbs+kpQ3FYah/H8UGB
5ao0QInp/yF9iREhH18uQYv6VE1XSA+GpTeDUdhLAMhaO68lqEd/UgbKvVnTQqMkKOmos6VQX29v
0t2fQH0HtQSuQEprlz8hR/O5m+JWD0pW5b4x4pUhcd3xTmhFj28KpbTfIaQ1BFSmY3D+Xo3PwO2f
cP3QAC9HIoMDSOMQ1MLlT6hxS6Hv2xhBndXieTbb0setooDmOYqH20Ndf2LA5ZSAGQRztivvAj3R
R1IQepBFNtsBBrTrnTNmPzM3S0+6lr1WrYqrVZVa8Ujo8IRSt7+cWQrfo0jJiwLbomrnLlNybtyi
/qIm1auzOoYCliD9GSkkYCZ4OdQ66V1cN7aO1Yzj5f5Sp+PPcaxs547OESSf2+t4vWsYDWUUNDh4
OGg2b0Zz1lSby8QgmszdJzfHediHubSmfp5p6lmkideHQ67A69Xypv6pF7Ny9H5dx3gS/I22ObRQ
LDu3mY7Xmc4YmzNQ3KZTn0QhjI/smvFgpns7Rtr3AQmGBWHpm/MRz2XNvQ15j8VPf5UitsPcgHLs
lZrzwWgs/XR7Za8QRHLPSA0EQ/YP4ZFsBlS7Fn2rtISB03hufact+ngaxt59tFBpfweyAEpVYedl
0JZT+zWiAYE0QhV9j4tWf3f7t+wdTBiEqKyAziXJ22zffh2mdpkhZQ12gndiXSb36WCrZ+mNcLDM
O0NpKD6RucOnZr03qd6yGobiwOMIokwr3pqZ+5GUOXru4+XT7TldSQ+xvsyEgiR5JYztrV4HNmxY
IWWdGThLV32g/tV8ioiEGnwoI8xsC6Ux3i7w0vVT3sb94i9p52Ar3kP98RO7x1ApcarxFI9tbfuW
DUU20FqI9a+/FKUTKvEiVWrkKDdrj3Kx2hcTQHMani0+4pVZ3yEXUc6IPeh1eLAo8q29jFTkdiNx
ACqBic9VpcJCxmToRyMo8Q8xLFTFRuSV4G7Z7Xs3X004DVncfRftmn2N29qIg9KlUUghKR8D1Zzr
+CB2uu5sS06HTfTkgkZHC3Qzf/pKnVp2mYrVXVKc0Dwwfo24YdxhZKT8D922BXVns8S/AV/BFFOK
Sr1bxdAfLMzOPQfWnqubwB0owlYkMamEFIyMUQhqIiQ4VPoQsdn0XxbSyweEjrLWjz0lZdugmPid
tml50GLb264yRAJZB4gTKvgmREjR41Qip6TJUxXzo2oO2VORqd1nC1/iR8qVWGCVSx0krSAqLJRY
/zGpan1fLOl0rrq++Agap/4x12rxaNVW9u/tjbNzB6NkzzalLkKmuAUZGoM+zFYBxiZpsuhj2aXp
yRuG8qDatLcZSLOR4aKShP/bdjOsblS3a4wfWNPqNvaYMyCGboB44cdL08IzNZdPDbmcLqUh1LeZ
gB6HZGt8ELLuvAV0i2BHSQFRWbe9fPVm25wcJ+1UgrQy+aTnafvV1NP0C6Rm+2kBUnpwCGTgszmV
8DGkeBSvD8/t5pXVpBFy4+IVYqE98LZynfg0zkX5qHtz8zAYHdAqmpAPtz/p7o6D/sXhA06J6I/8
VX8lajOzaQQ5VGB3cfOPbFI90oFYP4GWrs6VK4oUSm8U/bYRpf9WSnkrcPfSbYWMXX1jxou9+kOs
loHI3eE97ye2SLd/4u66UJ+jOmFLDIHclX/9wlrQC+IN0QJRdcmD3qPQaTRR8gjHDOk+2Njte8cU
3cFe3/v67EB6UyC5uSg3+Uqae+OcV6UWTHod4wbbrun7nhdGhEPmIFSoTxMaMrdnune+QApKSodN
UvKnvfbXTJXeURuzXbVAXU3x0Uuctx4Qy2+3B9l5e4mH//8gmysmrxK3WehMBWsH1SmEfSYQ5vPi
qkTWclj+yzICZMWljV4oNcnLjxeJjhCgwlcKzVijPJEhjvOJQ7AG5tzW4dQnR2r58vdvj5HUKHNA
+cOp2pJ+FGFqStWkhMapXj40I3aIS95bdyMOOg9YEv2iEtI8VuCw71+/sPAqoBlR9wC4IBf+r6/n
DZnInR5VA5C7UCgNk4c176Y3EN2OUIe7c+Qw8EYRpELjuBwqA8ag2Nz+Qe/FS/ddK7Vofl4y7KBp
/VYGOlbIQN3FBjZSga4t8Wu9oImqCB5gGQABA469LU5mdVrMiUsmq6NWdReviCV0qqjetUilnG6v
6jVAg7FgjuC+hiwXLuaba7GhuVVjrKQHwraX5cmesnl5i+LaHAOZnFlkHMYBHVdUOJSXfDERLO/6
igy3WHUFJL6h/IzMVRvOVj/1b9EY8I4y2r2rAi1feqp0vEnrN1dFZOOSHCPgGegxtK9GS3H4EEn/
jM3QL2hpr8Y2sSCSgoVkjyqDpc2RGkZAIdZCZQu5aviIpfFlwoDtPhqL4uzOrRNGZjIc7O0/b+72
VP3xhOBDkHR6mzlWjpUak8bVBH65GR9d8GNvjFyvKt/Nl+RR6iqmAeIvWnFeJ6GM/phWivE49/lc
+UoCmNAneU7qo90hD9Xmd5GbAoUkyScn23K1AAhoNXuQkERZauWsxpY23AFGbvNvJB+iPscJ6U44
NIaYz0mcQlcj0M+cMFnq4ree681zq2Mv6K86kGZfXTDpAamuxUf7eOdu50rgQcFgBYbOlmo66EpJ
Ft2rQW+2GqWdSL8rCne9u31adpaD/zvapSgGYNO+NailLzpO+LFjx0mS8bDUwvpSjuN7NWuV82tH
4o5lM8i2PR5O21d5GZGS0oAxB4rWaOc0dpHuoJT+T9Fjx/gfhqKJxbeUI26fxaRKY6M3ejsg5OjD
SmuqMDWt7N1ircvB+l3HGswK/J7sCgJz2+oStMJ0YDNiDse7NFDNsCnQx03h3nnoTz9r1eCelghW
z+0JXl8gshuicxdI/hZ33OV1XuAqY+itgyVdClGURxjplEW1zujylGenxsju9ng7ETaMURr0Esan
yY7P5YAITc1jTrUnoJRgfm/bYviB+jIA/q5MH+K+iV40lPlOWacbL9HirJ/6ej16Lq84JhLgR5lc
GunIiuA210mwfZzRkrOJsBrNyVHFkhpTcbZMSLPAwG59TR+Mx3h0lh9DnehvCyF1uKwIvo+vZ3b7
W61t94dVZc2AevjcfkV7AEHMxFrW2u8nZfkF1L717rzCdB/ZMZ3xCBVE+Xx7MeVaXd5ATINyKqsJ
svWqba0lqzkYqGQFjtbO6tkutdTFtU+vUySkcckDib0sdyOXV37KRyOtg5qChXkQx19fL9QOqAVS
50BlGRWUyy/a6XavRgZcPj3rIDhaGdEqghkHG/X6epHJMdxzCW+jVrEZRWAM2SjCNQN1mbX6Qzs1
hRKa0ne5EeTUB4/O7miUxEi9pMyKtdmlGI+OeWx7ZuBhM9o90lCasxehI1oUOHaPnuDtD7k3HBUp
RAmQW5UScZdLiIKfJF9h9yGG1P1hu1l1GqMk/Vbrh+4PO18LRIU0UIZSzeW5qX/pLRYbEUrOUhHR
/akhuvel7sdX56/wEjVWzmRj0I3f3CoghF1wjwwi1EYx8E2o8zsqfAlEnKUT9kOJ9MOP20u4d7Fc
jCkD179jYD1F43SqHLw04DotKuZJqP0sdwOk+A+UOeOPYtVcsPzRvJyzJVGfpn6Zv97+FTsf8uJH
bPaNFXXCnFZOJMAVccrxhsUVvenQuIqPFN33hkI2n7YqoAfS081QoPv6kgKjG8A06XS0W0T0qIiW
C0pZxFGBYKdYDMyH0pAMdmSSuFndhmZi4xWNG2jKVBjnJimMd6bVC+PsaWWbh16qIwFrD7mY751u
7r7Ea+4J1MPj+QEMbFQeNLT2Zk+hmF3MROkqbXaYGsVmR+faCey8t3/BzSz/IYlfJj8z9PkoOd55
JDmYNO/BDVjUSTaDTTT2K7gPDFYg9jIJo3qjzQTASa72ge6u4wHFdW9yWOQxFhkqL9Rmsc04TbNJ
A56nrY6ihQgRuLOvpWoahb071f/c3rM7ATaQGbqRFLxIXQGZXJ4ctAgB04+cVjJ3/mnO8zgE7ZCO
qa8Xhf4xFelq+qwQfjlLnlbnqTMoxVQgJ4thSt4r0TyFt3/T3gpg2UgcCdEAXpb8In8dZmFZSpwg
2Rsoqjl+LuNuChra7TCpLe18e6i9CxFBKJaafW16W2aTi+p/WlASDdJs7n5kVNsfG9TJkoMrXi7i
5q2mHSDbsCSUgGA3ixw5K8aTFdiZxKLk7+N5rP7CXnmR7R7q4J1Sqj8yXLsPnk15C2yH5VWhuAZA
iVrI5mUxa2MtiQjcYG5Mt0LnIWnvEiJM8w47OxH762qX4qSrTfxp6JYCK+55cLSDH7EXb8nMEYad
Kw1utg7yrVjqEQ0rL2iizEFne1IoZnUOGF8fpJvyIVHKMg0W24nxXQa7EqM5a4k5tNIh/aTOQvy7
FkX9HWwsCzjaGmbOE9pbSEpbOnUyV+0RbHXWrHmIncQ2T/HkoQ2VdWA0X380LUJXqZojvSy33RIl
TY1+asF7LYvhhcAEsKEuVPHLzlrtyBzs6tPhSMJIgDpofRJaXZ6BfjaWeopgKtExGJ6dFOEYJA8L
XpWkOtic1xccQ7ncbPDb0VvZZgHa4OTNGndJaE1je85tqbvsGtU5X7EfnsC/3d0+c9eHAequjLup
ngIK30J0FHIqTI4yJajMKD7pAhV2PVXfZbFav5iz+dsdsyNM1PWNIp0zpR0tOSNyCfIa+OtGaUVa
kR/SVlFQUaaOnBMJULp6YzSD9+o9wlDUBeDRy8xqi2fzlsnF2Gyhe1pbWLg3I1tRSIUR16gPFnJ3
VnIg1hKAxxZYj2LUVNoUPQJhRjWdGxfNaqF0952h5A+3v9n1HkEr7k8SDF+JJolxuYDZCCcyS3Il
0PUCrbrMs9ZTqkQrACfnbamav28Pd71FGE5uDtpzLkRM/XK4mMrbCqQ6QmmvjpB5QIPvvqUNBUx2
elzjvjxoQV+zqeF74YlG0EqxHxKSXOq/NoiKSDKSZ6AQRc5d5tPjQd50iPm++EABDzwL0CoGDIYU
9FNeqcMo/DSp0fjD08Mb/WGw1O8uSq6EfGqm/5s5dfbi9Z3VYpqH388b+h2zfkZMDbMfX9Qtjjq3
l2wnBKZFQUIIeEA2NLeNg4gAd6RbowQL1ZGPNiYlH/M6Xfx2xN2QnzeFsefU93ZmPOoIL7/EKaqn
t3/D9XsjeQZoGPGYkl5vAXDJas0m9S5AZbONy2Ut8e5Jq99lXVn75mJX3/ENwJGwRHu76KFh3R5+
p6fE+NS5mD/BGvDqy6/oJF41g1pF/D93NdJgeD1Bhtz+L91QsJJA+LX3S/iZ35NV6z4kpkjvKDdP
v/Aq6MDMG+PZSjTvri6mKTplHtZ8t3/g3rYGJ0x7gItdsjEuf9+fImGmOgoNRs89mXmUk69oSYD6
93hGrGINtb7sDgaV/9PLIIDGnob8OJ+FI7xtJxZp32E9js7yYK/W16ipax7Lbgr1xhnClVrlw5im
a5ApU3LQUN27n6T2Bdq3dNGurF1bqMTASwt0YTUNZYRMd0KvjNxHw6qOijo7Kyu750TN6HbJ3Xe5
skqip9VqsrJdNhA4OnMuEHlWDDPQtCUKMdbNQ1qER437nbVlVOJGiJwO/95suFYrUv7mKYt1Z3XZ
3QO9YRUInTquanYq9CL+nc9int4kS3Uk+LSzvAxOfMhBo3iwJasKJHBgl7pKsGKsGAeWO4H4Rxhy
POfadATF2nkAwAeg3kXfhy7h9lmre0eLxrGMQ68YHaQi9Dr5EPNir74olujR7C3r2+3Dsjc9eZdx
mCWedtvrmWB6tHXHG9B6M4Adpai/lSoQYgU3jq//YShplMILJyOuzbnsumGMPeA5gWKSTBemU95n
fYq3x4Lu538Yir4kuTulETo3lxs16ucGiSwjCuIl85A5NdF7LMu4Snwls4/MPve2J50hGw4woliI
g10OBid+KPGYjQLTjKcRPq9d/sA3m5ZdMyr+PI1u5k9dMWs+F4p5JL229wF5UhFrojWgs3UuR8+N
lg84K1GgYxT3kthzHtQFSuY+FeD4YFn/BKmbW04HTitRhtTSICVdDoYprWJNUxoFHipcxZPixd1T
1yrmg5nm2Vej0arfIsrbHh2g1nwDiNnS78QyFR+7fMGLGVpX/XPEMSHiXowXtNkJcbCksY38LdTs
/CC+udLOl4xgyXUmuAGUTI/h8udCUlkTRE3kcSqbxUfCHW63EjXDKWsd8wNxx6j5sUiat02rJmu4
ou14UkbEitOoH99Uhde9pw0muiDDqvGEzaS4d6i0vB4DITkE/AXiDzGhLQMr7tFOq1ZLCUaoTKyK
OhsnarRmiDAhztHt1Ft+0cN6uX1Kdm4baLyouHH4WaAthSFOy9kzMyCIOJCOd92oTKD2eSOjZXlT
W+Vrxb3k15DoTqoAKCFfZUCdtVJc9rhJMT9+1BGeCrAbJ17qi/msLerp9uR2ymkMJwfCEIRxty9y
KVS9n1VcFrNhSO86inwn+BrJg7dggdAaeVNhpmCNn8RUNF9jx6sekn6yH7pJOAfJynX5Q2rvguOl
hg9G8QoZjgTBiMy0EhiTLh6lnS5yt2Z/f3vCO2Eh5QfucOJqDulW6oBAiOMY6Uk4YhF5n4skfqdk
s4euZdkEJdDGu4Gj7q8D8mOpxs10e/id2ABNT8If+XTRx99cDZWhjK6xAg/CY1G7A1vr3VWzhjxd
l5ih1Vqq76JechCL7lx+0NBoyv/B0zHtywM+aIsUCSKpbrXIOYFnzUPc+JxTNB/fffKy2Nx9aBpQ
nQVVyWnZFrE6XdE9TmISaqITaQBAxf5itvPy2JlqctK9fHk2l1T4WlvM32sTy4QhTo9UI3YmTCkC
YXrg/aD8tzXitPda1P/sOEzFrJ2HmuCSik7xcyRoO7rsZba5mbAp5TmA2YBHULfy2Ck2Uw6og4QX
ragfGhrcnzpbGc5Vmhf3U9m334p88OQbW+kPyHd7D+1iwEDR9eH72MKxXgaYMgfbbOfOgoYjsRjy
J1Hlu/ziHUAM08jMNFS89LfRg4Ax4sQ92eWUnWuvXw6uyL31Jtcha6VWDK1lUyASrQlSs9Exflkq
nvEZbxOuZxkIkqQegeB3jpBJLRZ0GAVpGkibwSj29kjEjwxW9ypZ7OI9C1u4gOLs6QyM2hj8zhjE
wYruQHCogEtYvEUzjvtpE5c5s16kAnGQUDSqfp4Gwzk7cHXDyIrOOBy9BblrS6uQ4iEmAPEb/E3f
9t2khT06b4+ZgfjlFDfR6fZ9srfyJDUQrmi8Ep5u3u4Mr9bVzY00rNXavcuE/bUDyhH2YxQffOOd
+A3ZEKTgGY6C41ZnmXqnKhyLSyTpku8ZZhufB4yEfcOph+fEGMYPBgKDvucoxUE9ZOddoLVCbQ6i
Ep99e5jj2BoyGFxxuEyd7udIyN7bTTKcX72QYGCAz1DkkfzuzUIOCSqFQ9PGYT1V4jyDjHua+771
FzV1Dr7Z7oTAEdFRkG3JbUthjfBMKaMKilusRS9GEhsvdS2S/zAhxPhohUvtfogrl1cA1KakaK01
Dqt0ijG86kavPWUzxvZ9qh61LnbuG44kfRJWkNbFNuI1pgHoUErQQjndevbKicdsrZbUT1tv6sJI
MYfvt7/X3oiEC9IOl9Lclc5CXi2lXhlc8WtbR2d3QB7eFa6Ar2DET5lWpgfnf288kj9EOuQXwxz5
cjm7WBVT61gxle9WCYdWM09cQoOfiMT9nPdQ4G/Pb+dgUwWnkoqcI81VU78cT6AHFPW1GYf2TISb
R5Ri7BXNI/zEjogHu0O5uKqqBIFk75udUrWYJE6m9AJrGxGmUd0FTpla7yNeptdHImySP6a9XFdQ
kS9n5YjBVubKKMLR0IUfR6Nyr8a4SSSY9by+4EOdicGkbwxgkM1QbZp6TiXMIlzntn9r6KX9iG3u
/JwJ5fWMeNmssMlt4SzwMG2ehrJ1y85O0jzUkwYBhHxAxclsu6r182laDpZQ/u5NvCH5IdJ/lyLI
FRTUIFEWTpvnYW6p7RdgN+1THx8qpuzc9qicwVCEnE54s93ugK5ok6VdHvbQU89r5mK+0aKINQsX
ey3Y8BROV+1X0jmvNUQk/4GlKLl2cttrWx/Gli/ZeNnMYtpOg+OP+2uM0vITIqLDQ71k0cE2+ROQ
btaTViulYoYjz9uCsxf6IYWhtVmYlx1BhT1EZu2PdjSHS+SVLwM1xXtlqJyT0U2U9Opq+F2VUXYf
V6aZBnXZGv+Y1pz+7/bx3/nKFPIwcQLEQS1v++hple51RllnoUgnFZCkAv0lyY+oNjtfmR1Eux2I
PzIZ2x5itBI8jXif8JVX1whzRcVqUycXwYxX5PZ5mR37SRln1MPTtLEPrtSde4dSGvcAGREV4W1E
AWVlBb2RF2FRrNm/laPEz/Hc2o+pW329vZp786SHDyKMsgEdnM0Np4/OVPGhAYdUnf1IOpI/EAeo
J+r2xmnkEj7laSF8AgDz/vbIO88Gby+9HI3iCuA4uQZ/9XLGPlEbK2OONFbT34Nl9ad5NSb8i622
vx/L+QidtjdVqs4Uc5gB/H/5538NOCTChhcF+jof1enO6Ife7+ArhVDKkrs8a9330SQaX0cv+/1/
mCpkOo1gFKjVFo9PkpOi7cMim+ha+Ehhz597d/2xqstydivPebg93N7uoVpAW5rCsuQ5bCa6Akcy
swVFg8mqvi2dFQfagjaumgz679tD7X1E6QROmCGjm60OaVN1q1cJtQj1ubLhwFXaP9VQlO8mjS6u
YRfeAYLs+vBTU6MqA/OLWj5v1+XU0k50/ZQreCimIg9w56nf9JMwX40ovhxlE2FgW5dXdYGMwlBg
Aj6YKXxXwL3vlpluwWsXkCuGUJfHhA9Fmnw5IU3p1j4phIS0Js5HhBh+KKRS9xB7rKeimvSDi0Vm
gJdXOsNJ0xQSNvDL20KhOVtam6txFbrSbKMmOe39HBbdG3WhSGkOeCL71izTtQVfSd/p8vT1aGZ+
gkdNAGABoM8/DdK/jmETYRukImkUgr5ze9RWzeaTtfTjY2R4yrlAWefV8o7Y7EidD9mBgY6yfbGn
ykwiTHZp99BRO+VNqp2Fm3g0ocwjDYfroyeHAqDFzc0ndeR5+Wtyvdl0lHValCTHaaDfTMviBWpg
N/pFZHmvBp8wFIkFiQxq3SRNl4MBTRvc2JurcFIS9U2nUCtZyrTyMXFND2KBvX0jHbDAosIpudKm
yxFjRHJIaojhloq3W6E/2ZnQw8xYvLt11YtTow/r2U0iAAeRHv17+5RcX908AnTwwFBQnrwWjnLy
xK1dvQynevJ8YyaJqoCmPOB3nwWRuawP7Pk1VNdyOii9Xl9wjEwphdiKdANI0eUaY0kvnKiRV0Hu
rm+sbP1dWPpUAppEUxnvlPl0e6YyWdoeUPQapCgQbz9gv8vxsgL4dKwynuqIX7MmzNGvq7l6XpLB
CVBybvwxGZIDKPDe8koYzB83UujVm0HrmAS4GNIq9Ez6QH1ENIVyw4RelpWD6dDyc5566RdNGePX
V30dxA2kTjE6VrIIezlfe7KnRSzcf20v/jWUqn/TI14eUv2DWeE46D6ir3mUse6U9nmLabbTA2FL
UQa9HFWp3MaePKsOKcmi8VR5SmEGaWEbP7gh4uEUD7iqPyjIjlIxcyLciDDg7oBKT1KptZ/1I7CV
3Eabzw4iBK81SaAGgLhZhooYcMxUxAGF1Wl+mzviEWl+1Lb0ITp4sncnj6SxhW0WFbsrdLnVxL1l
Yo2CB6s9h01W5o2fILDQ+E7b8Z5a6fRcz4n4ChieIIxUcXq/WvF4bs3Me3XpDEqLtAEiF+V+3vYc
ym6BCWcghd2a1vQB3lruR9FQfHWxpCbcdssHC42UMBri/u72QdsB4hDYy5bnH/9UtPAu9wC3V6lE
OQl3TCymvrSJNb+Y7upZft3lzJuwFR1gi7iwe1bsNPkSFVk3I9likvHd/i07tyu9X2nRwUpAm9h8
/SVTVnza4zwUWt88jrPu3udaOT9W9SqxcJHxWA9TEaAQMX5eoDUfHP/rzScdA6SKNNp89AU2w6+p
qbXNhCCWQLs/0HH5CxZDSfxpVLqDFP36evvDP6H/gekT2nXyz/9+H4uxWVLcZTE+zz1Iv1rzZWry
NUSGvXxQMGL5Cv5ILQ522c63prICKxLONBk0/3k57FB32uLQ+8ACZdDve2hAYQ6B/QWa14xcf+2F
hbD1j1Ax7tfZrZ+0pS8PfsPVN2Zhbdnc4j0BobG1zFGKvi8GQ5uDVUtBeuUpoFH0A+rCn9VJcXzN
FdaHpF7TgVJ5t1QnKqHFw+19drX6/AZ6xH+ckYBRbKmhswLgQV9qjMSVznxASmw+O2abnZJMcd7P
Y4Eh83roPn31gv4ZlO4oYglSqHCTjfRaP8RT08yBqdQNGinJeB815njq1/KrEkfT+fYcr6sWcjwp
0APtEFzDNqKGzD0Z6DTPCHaW3pe6sJvHzkv6x0aINTRQkbofPHt+5AF33nVjFr3H39S6HwdvfK4X
1fjRxsNqHXz8qwdWVvbAutEol3HEFrfIdZKj19jNoE0V966qGx3H+GoIzK5Y/NKF7r5YVoRoQG8e
LMfV2ZYjIxfxp1xC7LzZ+RZGnt5Inz4YCi8+tV3bhTDts2B1uiNY4e4kZalU2uzIMS8PWUmf1sQv
bwocu1PeIOCo+nWaafddmWEf63nKXae3na/Scz2ITndHZkiZXhN0bwVrPFtUitcwSdeaYPh1S6u9
VEC5fq46FN9ac7v3+FKiOIoUnnEQhF9lpCyw/LYgBWir8pZcznoygb5SUZ2DqB3G8qFODeN/MQXW
/OC92jm78mnA9gtiD0jBzSWN/sJS9QscC7dsyrOYElCRKS65H+e5n8+1UbbvnXXE8fL2cdodlihB
ZhooiW2lOJGCN7xuyaegdEpxjozZvterBWfWTKDu0q9JoJTpkRbnzvdEFBI9YdAAIKK2dyVgbDI6
GwHEPu8yDJS7McS73fBbuFvwDabol+HM8cMgsiOp2J3jAsEEadw/mi7Qxi+/Jj1qbYJbgCRupVYP
yALkb11jLv7VGk0/2LQ79yJFVV5CeC2yTbM5LvnaGgNx5xQQjKFiM2GghGFG0z8Xo2G+VHXcfX79
p0R5F042kaZEmV7OTddjlHP6dsLaMoF+ka3FQ2F4iG6oVXdKuwjNwSWtXssBo6jxB25ALYq7YXsb
cxO7Gpj+CQBUstxFCNM9zk0fP8EFTw5OyN63oxMKfwd9Whoom1KKynLa1sQJ6ZBQPadZp764c1cG
qTtG328v5Z/y70W8LqcF0cymZEq/clseHnoLjwYnnoLVbfKvS5+iKDHzmiBQOaOe7yPNmHZ3q6mN
tt8qXvTdi6f8Q2F60exjPTPCTWtzCCqRoa8hMp3FO0PRFXQlo86A2Dyq9jdPOOVLVhXxjxbRfoQ9
rQYEIJVc/Yh/tLMTEVeAbkoQCut0e4UVWj1T3vVmNH7AgwPb0M6u4LWYs0V7UgYKiQerJ/PJzepJ
NWa5HeQZ3wIedaRe2qQlzEyqWRU+lekOtrbtFpafFdEcP4phzr87rKG4n6qyLN9n7VrMIfVLBDlH
J0rfuVNUer6lVyh/pELxzDA14uWujhv8Y5diWVC8sNBC9usxE2/nai4PKpF7i8a1SKbOIeY63tz7
9EMLO4mUJSB/gp2Ot1z8qxutFq/J1EtiH9WP9EiTdOetkZubijmpGyG7/E1/Rc/a6Cbd3GtLYDVr
8z72vJ+DXusHe3tvEMxZqY9LqQFKH5eDlL1ItaHXiRiSYvSTyrShx1T56fYe2HlXqEECMgNTALRo
i/YSTeOm6qCgOq5N4p6vOz2YYoCIoMbrvShrL8gTz3t9MGTQTqE4J/13yQYup5aZ6+CVgjAs77rq
97SKRNxZXLdPa5wXR+DIvRmCZEMFB9QPwe+mqKJOojeymIC/adKiBUBnNu8H9Oq+dihGwpjJuju3
i+33t9d15+mkugvOnM4uQqNbzFXWz9pcQ/AIllodhiCu7PR9tqIaOWG3C+q9sPJn1czTl2KYlYNv
unMBs7AQQqVtCQW3zfYEMpdqlcc9Int0p7Fb1fhMB6IXki+ozAcvy94+ZYNKPj7Y+ivCRKV6C6Ch
ZAmcqrK/88113Vcz+6gAuDcp6SULVwVoLTzuyz0jPK/tLBrjAcacK/bJTf80LY3xiCoHSpC3P97e
WFI83qHjSqlx2y1feKLhBQAxHik5hVayEPP0mto9Z3nX/4ezIDXqeb0IeJytxkeF0iToQnwNOg35
8YjtEaz0XR9XVcsOsp+dL0U2xv1NL1UCIDfHboRZgXwpJ8FQUTDvGzN6yquuOdgPOxcy9TwcP2DY
SfCb/BV/XY6GWQ1GudKQ1dqEvsLcaA69PGsofWtK6vZxLWz7IPa/LqXhvAcolzAVvUNK05tHgMpJ
y+vkIqm9Nqly4nSr/0JiMl9QfFp/480H0EHL+ga4g7eUagjVvjyrrdLrftvXyFK9ev/I5Bfyh7xZ
iS4vlyApYyBPVcbVTRXFz5bVoVM/1ucZ5ZSDqe9sVYtEj4kjaE7hbvNNs3nRM8ock6SY2GhnDfbn
sc0MyGt5cTDUzpVmUaQz6TNy2AFAXM7Kpuo2dqM5BQbyIvf6pCElpFnzG8XRl7eWyNV7t8X5IO1i
492r15OGsdQWwSJQKn9cjpwOrGNkMEnLWpM3cdEYqo+YV1P4amm8WsaIugxZjdSk59VAyfBysNGB
tjyuzhxUTp9/zrPM81XFsJ5By2YPt+e1c1SkBB6hK2UZoGKboczWshsVSwNolMr8Zu01/c6S+M2e
LR4a3XxUb995ChnPkb0jBGXBZF5OLff03ms0C23capzuoGuigDO1n20tMe6dwlseKvXQRGtn13Cv
8e2Il+CnbuGftqKid5pOY7BaZl76MS273jdXz36Dg4UuAg97pzqMm7b+pP8fZ+e1IzmOpeEnEiBv
bqVwWZnlfd8I5VaU9/bp92MusKhQCCFkTc+gL6qnGaRojvmNm5Z7Fowb54NCGyAOTgkUS0f+vL9u
o94LNYh0LHFkpfkvtFzyXxQV29e228X/EGnQ5SfQIKKGWrrOJO3GcuPIFCR22JE/9MZkHRcjGl7j
yoO2P5cFqvnZvHOpy6ttFcNfDbraQ52WaMhfkwFVdjEE6eLMD9kSwTkWqYMHeRI/KnbxOyf7DQqa
9i9/vWhH0vmkh4x8zU0um6pWK+ToSACZh3LUqhNMfAWD8GKvUbD1JaFdgIAibZZMvusv2ZhRRBmJ
1Z3EMF+0ohJBBg0EnU9bO90/l7f0KKA4UnKL7jEo/ZtgAwehounQKAycwcaNq6mSx0XRk0f2dxpx
HfSoyrpeL95h1fZoJf2lr3K79nOziWERZNZZRu6Ez4v9GzeFJSHr7q0fokd/9f4v3TrREOMk50ey
Ku3Vw+dOi24DpCb/nQvltzOJSfe9VisfirLHpy5WCylOon28P+rGp4C1wJ3F52CB1oEE0O2iSxMO
FchjjCfdrH2dU1Q+OU20fP2HoaAYSagQPZm1E4IxUvBrBrVH6rpRPhgFyz+kc87FVQ/GTv9l46ri
dQE8z1ISIq3zb/oFdV5Ycx/ULsLVitFofstp/9QXiYJ6ZlFhA+7UfjNht3d/lhuRGSMTl0mZHgqY
q1dcn1sq3tbUB5lhKxfMTO3AM4S2s1k2Pxs0MQlZlPxbuZn+ugvrilRjMdnVjeU0X0Y3Uo6RXbuO
b46KtZP/bI6FDROXLg1VCqbXY3mzYbZMmGtf5YyakWseFJdkFrzefLi/eJtDyWI+2hqQp9cmWm2k
wkpKXHajN7sX3AZSdD1T7cQd8mJUACgPcE+UX8lEJNPvelauGmViofsXeJUTHuPB8Q6d0CPUK7s+
6MiUkRwv96grt+zH51HBIoOAkL6Qq92xCFvNRWH0wYDY+mnJnfSIEuHyxkWh7gLlwZlPVWnWp9RN
DPwRywxXizIcnkI1G0+GnoznQRlR63OiXhwzABSHopvnPbHZjatIhuCytcTfOEDXa1M3bpREmcbp
aaPhbR/PCY9C6b2Chpd8RJvRO9i0FC/3v/3G60c7j9SJUI1zs4ZpmGgUAGFimzX9NDw4CPl+T5Nl
fq0uS3Ie+jy1fD3sw6ekgcKviF7fcwDfmjXHSQLFDcqa61dpSjoKOILwxlAm95y17vTYRGRzkRn3
h1rBjGPRlWwHDLN1Xch9ILUhAT+vJWHiTm/1kmp8MFil+zpSRtXvofSe76/t1rmiuU5dSF4ZFCWv
P+hk6hWK4lxKZl23R+Q8i1913v4Jk7rbSRmfa1mrIOZZfJoGh1RnWSPh+5A9AxGuD6o2dH0EJ5W3
VdF9s+2ueKMrUUGT0tQPaqTMiL4WwOTVsj0oTW0+FbBtvv/DvCU2T5bEJLDret7lMIoh1eUzYIXd
yeiUn0NmDp/od5Q7rYeNzcNTY6HCYUmQ2togM6LW3KSl0nEhx82XtuiVBxQ/WtNH1nx5Gzel8d4M
MaF9eXoq0etU+zDBQQhnNcEl8fqhXOo+mCjEwXCvXX+yOvvtlE8vJ5oTfCM2D1KUIjN6AasARaD3
H3IPk+L0qnmqKjF9RkiEEoQ+2r3klDoHpy7a0B+7tsMpCzXEE8Cj+gHcd3H2zHKefLdIEvM4mL33
4MU0nA6RUirH0aqnf9jy4NoI/SSmnRxdfrC/Xsgq05oqHj0sjAXl1swT8SFLwuTJHpo9PtLG6YLw
St1CIo1undcmZS57pa5YmBqOWjxV4U/RV/Gj7ZTOzjbbuC5kMktrAQlXXuNV+oz/g5JHDBcogJHP
XmvnRy3s9E/3j81GMgumQUoNAyKXWg3Xa1fPI66aPfbPnarPiU+l33vK6Gd8r6bOfZMoafM/9wfc
WkFSLcnqklSMGwwt3pXjXBpdkCIQdzHN7pOmKJjhxO2eJtvm1KgFQqHBlJlyyvXUTJFVdT0yEkJr
BIEQxoI4CtEKytTpoU8KsfOqbdWzZBQo411KA+aaaD4LM9KdmrWkrRKCNFTF1wlVy1eGOWDpIJpO
HEWVjf9l8ZQ8pn2ovFF4fS9DWvfqP1wWAGWkljjAcnqI13Nv67EZsH9E5HBs6rdZmBuHGv954eM2
O/3LWGCiicFJwBDpvx4LsLpBAss6V3kk8gCqv/WqLVFQ9JHomj7c3z4boYPUVaM6DzoFnLlxPRjQ
m0xZbAYrEWH6Hqd9+q0GffLesTNL8XtdVw5lroiHSfOS0tdbzdt5Z7aOpaehDy/LBfAfV9ew6bT2
QlGkC/IpxI22S8MTiaV6+odp/p/lIQBLEBLX0zTi3rHjhlESrxsP4ZioPlw62L9zbgXQO9MncH7x
01imPUThYa/+srnKBs0Isna6jOs8YPHyXKPYIw9pa5zTYTaOxtJ1D4vTLa86y+jO3uQp9GbN8DJV
u5262xcWXCXnh5AdXN2NcEgzTnXSmeAIUm1ZviNg4h5DBPySQzl5VIPz0BkVfygddecyvL2byHv4
LyVg4jMgtderXrh2WRZCjEGJMkbAWqvvWrt521iZ+u3+932Oja5jJ5qEnE9SLcCDFPeuh5qVbDKS
lrrIUISNdRyRj3inxWZFL7QS6pe5nMrHUHeU/6YlKd5yGPSjNnr1g6x7f6u0QXmCweZ+LNRwT3Bv
a/FpN6BISmIm62LXvwzwSGGkTtgHVhLCt2lVLJkanKNLHxFKgbeka/kx7vU7ae7tluNYS50O1p27
ZA2V6XDHdkzswQLPS/PaLxd3Bife2u13YIaaHeB9npyNoRr+EwvymafUWPCtuv9Vbl8MfgOyTxTG
uDdvmmJL3lbO5IDxEOVQn/WxCR/HVDe/6jSrP9GbebF+hixu8v+DIAfUDu779VIvjih1N6ayO+ZU
m/BASiHBY4IGpMXeeZw2tjYzAtgB0Ivdtobm9GgpO03GvzvjYQ5qMUQAWVz7UMBc21nFzaGQKIP1
TpZHUf56VkrSFXZtUvxRPfGmdKXpUu5pxaOt9y83LpQfimsKIBASxQQx12Ppg5NFRUWSreC52Twa
TZ7OqJ/02s553dgZMGIlnRPIM+3Z1aEQwovVwWOcqtbGUyjMN4mxhPFBjE5+0OYx3Yv2b58Z5Oyo
XRFpIk4E6vF6YjwAsYF5MbVMoBtvoBgmB60SeyiqjbMu97ok8tPEBItxPYrZpIrVTeQUMxLB00G4
6Ez4lajTyzw53qfYbvRjUoXlnhr85uxsIAwUIgncb+r7kW7PGF+TCgOmAs682N4rIBvqHqhyayty
u1Kf4z5jo8jf8VdmoPaQYSgWU+UxGjCzbVee89EQQUyh7XD/7tgcSv7bENmUQeBqqLTKwmSkBxUY
lYpOHXpYr/Jh+GX2hbtT8LzFY7PpyUCllziHjKj9elYKwgwUvCjkmm5bB43Zlr/LYnEPWW2mD+Wi
2E9mZ36IhlH7mcTx8hXLpD0m3NYHpPfNmUBugqt5NVs0sq0Oh5I+EHCYgshelhO63cnOmm7P9FmW
HbEz+lCr441hWl42WQ5scxZoHYZj+DBYc35M7dk+hkZv+nYI7YPCNqVXlLzPteHFOz9i68OCGaUf
DO6civYq4DOqxhDWQJemX+LkNClpfYCVPwS1PXXHl+8holuA8jL44Ctff9hWTIqbFyXW1UViBS0O
kYfBSlUy/vrFrD65h6TiGfOSt9rqA0Yd7eZaBe6HEnv7Ux3a6rMnkvxBAA3b2a8bC8gegXhmYvoC
ZWh1yeRzZxbKUtFgIyE5mLmoj8rkoAg4tt7O07NxTaNvZhOdIwLKzbbaL6MaDqiTUFhUl3Y8xXo3
oLktZWhdSm9RUKXm9HD/k20UwST3BrEQpM6ANK5BDE1uZYMqH9YiQdvFz7OltN71yjhqx7Kd6l82
BNgOwHhfWFDvEud9nTsaDMc2dN5OKa4iVPMLrf+x87Pk91vFl8BUYcF5kppOf+J6KyWTFSm2yx2R
FVN9UkY7rU99N2LaxtVR/cFEuWgCSIBC/9KK0X6d5jrl0CQTxRszwf/gabKEQ1cwy9WPnTGl1U48
shHuyRIKQvH0NQhIVqcKnZrJwkedQgow6INNrSiI6tQ8enX6Nq5xYuSx0i7DXPfUwlE4vb88W1tS
13HwwBCAZ2gNkS4di+TcZsKViGMfLpvyGEfaT7W3tZ2i79ZIJFJQdWlNSS2E1XfwsgjhUpxdq9Qt
zmVJBRSojQisZRp3Liq5ZOtPTlrMskr6LCCI66HMMi2HoZQNBw0VwaqJKLs2yvwLHnPv5/1kPwpw
INQlkj1I6sZmM8iaeGZ5+kgcVtGRQ421hW4GxiQCyj/qU/bdtspiB8mysWUYxZFgQC5HiBnX88PB
SEsGEyQL81kO+dLBoh08xN7UNDwrnSlOSEbZh9iLdL9UW/PD/T3zDP5brS9YRG4XUBiyLLeKa+PB
MzO47UPQDRhmX/QQIg6omjCc/bDVRAiHAULM0ekrxTyGouwmHzeK9k8Cwxbea6/+VxeiPpfYFJ2G
MBQPIxqsn1slje1jlI5mezJGoSt+nIk2RlyBq/QYl61dnWaKY/HFtbIxe+VYSnHMjMgrd+Z3s1OJ
JSTA3aTvRz65LjkkDdBwC7B5YMbZ6NexUR1MUYpzFzp7++Um7JQ7BZ2yZxo94dLqRUisIY3pDFIx
imbrsUNoKfXV2lUf4axaJ6dzoSoT0u1JWNy8Ds/DUrYlXqGGvhbcrBwcyDIehSCaPY/E22tPZgsx
eAlnB4Rn2u68DbcrKg8ECBHGAvuwPpA51akKuXDq0rXjnat6GC9Z2OdB5+rTTrF4ayjoZ1KfwyWq
XiM6yFyT1sNKIZAWzofOMhvShX7Ggxoc3/1zcHPNsIp09mnfkd1JVOf1MewL3WrjfGCoBdX4QB8y
50eeauFXSJbtAZvM8qFvOufzsqTJx/tDb+0bUOMke7LU76xb4YY1lolqjl3gtLMLNMmxD26VDGd3
GqMn8Datr+uJ8+JzIaWr5P+o6zLl1bWTKi1+Ji1o4AQOnN9loJ8clN+PYdbs6SZvbVAdlCdUS7R5
oHVfL21qNFZieXOH12Wb+WD55sPkoWmZWwitLIOt73TwNsejaGszGgH2umdGhZHvS6E/UFVFPeYJ
OPXaNPG8cTHYpI23x5Tf+n466R5rCemDO+Z6fgRSyTQusXR5T8cP5djGl85U8iBqKEc0dgRepJn3
nD9uG/FsWAPlXom2IWNZr6qulDVV75zopkO84qQqmNCchAJTKTB6x3qbJ3buHgzP6R9F6ynR21I1
u/GdKvqFj5CIcfSL1ihczDh7F5eBAuolf6h/hN9uvTjbkD8WPflnP18y3tUSkV1OGjoQVF5RSzx6
k5u8CWPyYlLXPa/i2+yKscABkYIjn00quTrJ0RgX+VLRyAwVVfmWJFP1LTUX8+L0s/aza9Bf9jV8
yB+5BewPpuIufzS16d2XxmLyVxDN4fPHJ3LX1LxwhliQIEweqFm4HHrdTX7MRUd3rXLV7Mv9C2Rr
w+PFAtRY+gUhUHW9AVFEzDSkCOh29Ub/dgrTrvfDZWhxuAmT9NDF1R7S4CY0YnZcVtD/DOpU1DCv
R6yjtNKcpuZVbUvlk5cu2nshwp3IaHMQWQKjP0z8tS7XY8eyLKNTdUGGL+NnK1WI56dB3wnZt94Y
3Ij/f5TVdtE0IKGqW3bBgG7aQcS6FwgvQ+OrTezjy78T1wSlKbqS9CVXAYLb54OT01oOFLeZn6gx
qu9LoutvPea8f0xcCl/MHeAzkdtLTQfuQXAw158Jk8ypUCpayBrW7EGI1fQ57l3vUjbIl9+f2/Nb
fBVHyrGg7TzjQEhVV5ODmGZZk8EDKtDDEEera433OiUa+0TnuvmojFWX4ItWT/ER8+U5PhLORI5v
NUX3GW+62fEro8zzIC2LwXngroDuXuj6IBC4r2zDj9VMe5eIFnCTlenpQ4KRm+kP6ET8Hk1cgv0B
BUh954ttbQ7KXlxYGg8teubXC9jOWWOXltsFnrNgD01h9tQZqXr2aCHvLODWIaYES01GRayQssL1
UI5bVE5h0ZwqpnQ+NkNu/aTelQajbSmH0dD3UtWtqUlaDt1qLg5SuevxhLoYsRYujKe74MuV3gg6
J0/OphnuSRBvDYWKCYA41OSgKa+G0qLMpIZI29bJwhiN47F+mju3Pgg0gnbe/o0wjuqAoVKzkIDQ
dXd8sBR7MGfRBz1G5n9CQv/Sr8x5CGxVqV+Bm8yPYwXGe7T6OtoJITemSfINmp2MwubYrS7FpnXT
uKwKkn89r3y7trpLCsbRd7Rxj/gtV2x12CikgfwD2U1bae2Z4mhzY9QFkQWxqnh0IzcPRuzNz/fP
9NaEeD9x3kLdiS0pF/uvOvMQVnbtKbxhtecgBINXia/YuF9bhbEnl7w5FAAyqqK8XzdJBVevB7ua
CXVYQUy+qJvxW93p40DGWGU//2FelBJoAVPcugFpzl6rWhjC9QGCcXGAYGP7KsNj4A0K2drn+0PJ
b77+UHC2KF3AiEFJZVX7nDBEtJOMQonmYQKp66V3NpahP6XpaAVoOGuUmscX1wulxi/FQqIP6gok
TtffDSncZql6BgWwEj71oaciIDuC1jRRMMkrZ0+oaGuSJGhkLmx+mcVcj6cLKCpOzENtuQUFXqQB
Hz0vNC/sKQfp9rkpH2J0bHcKsBsXplS45lLhcZN9xutRPXOmVwoyD2hcMviml6YnD9kYvJyRpzP7
snx53oteCZglkGpkTes0LU3iqESfuQ3KfimOqdOrl1IZf4HC3msQbKwn3Gt6pxgDUc1bk9Zl06Br
HaXloQOqbOEd8jWPIltFtVxtB99RG/TWpk43d+jLm+OS1UuhaEJnZ7VvuE3DupFR3dQY08FNFAxC
xsJ8LHs3PyWlJejF5PXOjf1M7F4dESJ1NFvRckPzYM1ObZt6Qc8b59KqjMU7BWDAY1hO0RO6X8DP
ba1/oHI6vu0GispYihiBk6j8nL4rD/rSdO9LXUFBpJrV5ugZizrs3Oob24x7iR8IuV8+KqtFqYzJ
6K2SRNma8c9tijw7R4YR+oXXzQ92ZKnn+zfGVv7C+8VfhFLQDNZRYr8Y7pCOBFI18kRu0ColYVKq
57F7UYZ++aDNRWue+sSLXlFuLbXDqKRDAp0HJ4zj/d+ycSvzUzjVSMHKGEH++V8PgFbHbqSrVCbE
1Ld+VnG659JE4w7U5uH+UFvLzGGm3S29Y8EPXA9lgNHuZ1QgAx3lCXFeapJJf3aMDqCmlYs3iWdk
e2D2renxfJJbgFfB/WJ1bwneNlsjKA6SUJtel1W5fHCrujrgxSN2prcRl1Cb49KgncKbveYrIvaf
dX2oc3m0+vw7DpPZ70SD0UEjel/xZrx588L2h2x+MdECUV4pHEhpGZmPG4Ct24m6zzqrRazFDGFX
tGpgUOQ5653yYg19huJK93A0kaSE9WMH4JL3ttbaoDNnNSiTOn49zd7vODLiDy/fLUTJqOzw1FGz
lrvpr42ph0s2NtrcohRgi4vVIoaI4/Q3xW6xZepICe4PtxFu0eYDk8G7Cohq3djH57RXrDZsg17o
WVDqWXhsRLQn5b21HSU9UA6EBOFafC537J7PLyjJiUILsroqjqTAv8verl7+lLHjQXXSKGJv6PIh
+Gv5POrxGZr/FCf6hkaR7rXf1VaqPCpOsVPcvIWPsikIIgF4A9yXzNLVWLHVJplrtwEMlYI7hDpg
XHbeUWk0AM04oJyiOl8CiMk6ciZYN2lzYpyixjF3elZbr5vkUyG4RnsYCN71D2md0DJKw22DovbS
Ry2u1HdF239w2yk9KQPM2kmIF/uoycnDWEBnDhAyifj1mCM9HBtDey7QEO6emUTe0caNxQf0tieq
szk9YgXc9ujnEP1dDxWTZWhul8r80cuOttN/RR/FObCjP5gQeR8rcBw7K7p1qclGJ26d0ldwDRql
rNiMhpF32MdnSOrga/89HJvyidpHjrxDqT+GUJN8ooloZ1dtHUiKyWDWgdUh9LDKTOwpRbu3o2gj
hlz7WpRxBVoDusv9Yy+/zjoyYQSYPGQkaGesIsxuAMdkV9RrIA0oF/r68ffYKCrkHsfpaIwtFH9k
nC4Qsr/ACTH2LAC37oO/h189T001xnbuMcncqOxA53H8b7C87oTcf77zPG29vjy+NI25DegkrdYz
77VGqyMuhDifnEOujZPw8R00giiiHaBNk7KztJsDghEkoLap760TWCWJ+4VVbwNXiZITURWw6spA
pq01Ghw58Zz9h08pRwMjKK/w1VqGiaWABDDaQIt53H1YqcUR4fV2OoStqXzgT9sPXeVUvxstwQ24
6tKdCT8/fuvNREQHEpNiPSCnVSxFdpgOg0Ww4SbD2PiR15ozPsQifGfgBvjDmBdt8Su9rn8iGyRg
biUx+CbVDaN3U1xPrj9Xg/N2wL6q4DZJ6+7iQvC65EIU38MW0o4fpl5b+tM0qaPf1o6uHGezVb/e
X8itTWlTlJTARHS613ydMbPcBaOLLljUdDzoSqFAglVMLDy8qFb3KN1b2+Tv0Vb359BTy9Hlk5g3
ZYqEU6oiNB1b0bHDLg6pZVXsqLxvDUhhAEkJDAwxblq9jCMIt3b0qEPoXb0E5Gf5RUX3NHCzuTx5
bSXe3V/OrSsGFBZEGF59nsnVroiWPMlnheZtnAjl0UD7UfVNe55VyJvzUAU1Gnfjodd68SVh6X9N
swmF9f5v2LpMYdTJkjS4eCj01y9HyiZU7BTYYp8J9XGpGuujbed7dNXnZGF9AMjyJEoX7hWE9uth
dKTRkrClllqWYknPMc6iv6NmRGxeybHu9kM7/JQXOBGhcZzlh1jLxB8ndOuYphE2khQPI0pR4zTl
r5XCCLsDurjD7I+KsUCAb/Llv6qvujxwDUocfkI8g3KYbXGT6YqWV2/iVtcgiGd1kR1Gt6tfjL5h
b9BQpQpCUQk98tUd6tRV2uSSCDn1uf12cEOORKWmp65Td97djTPIOy9pYXRwYTjJD/pX+LY0VR/m
BfUWIwUJhlqFdSH4Cn3Hbp2dvXGrPiAxnXhr8s2olt1wp1EJJbxxqQl4YZIUgVNVkHUXZE/+ixNd
eU+nNXH8KEFW9QF6UG997KrSZg9b0Zj7sWXjHbDMifYaqwO38RO16uOnpm3G9+3MUp6qyPSq4P5+
3oiEZGQAnFm23yAjrJYH/O/cJtSATbADp3i2qqOr6EVgL3r7ey5FFftVXtrWzhOzFemiekCdT/by
JQzketzKyWw85qngN0ZmvlHa0TrQ+hC5X1I1gRWM2DOE/XFIAzetx+MwK55vN2555Ijr/3N/DTa2
CKkm0rKyJCeNmK9/CyD2bnEWrw6QfDB+xmKAaFG7IFvbYU73JIY2FhwyOKA8HnN4imsIkatQh9Dc
gQ5Tg5xurujaK5UWzdEpXQ82YZr8p9EE3fnKGzNkUMrf3CdEgusGK05K0WI2C4OOdXYo+15/aMrl
a+Q1xeX+Wm68CdKamAoBLzdlffnnfx230FDGxXYbks1EIzjKzNhXdLcMhmzSj61d7qGQt2YmTzYA
ZMAoNyBWdzbdpMpo2NXZPPyyKwDAVT8m71RwWuf7U9scSp5ruYScwFVyZk0RopVLzSLqBYfby9vH
KQt/DO4YP/zDSIR6/AckAO/M9SLmndUbZVcQ/sR6iyJUYZw7rxoPWCbUp/tDbbyptFghn8B1gWqw
BpLHaPjQ+acMUcScsBQ2cEAYIY6TPuMRQ5vkoGB9c/SKoXks9GrYqUs/77zVQ0fxA0Tds/AYUKnr
qZpOpVYDqqrP0un1qVyypjk4qcuFONlLGV04m73wJ7WqKj/vuszlanKiR0eb6PdR6LMfxqKxvEND
Uvz5/tps7WWH1B9kL7uLauv1bxtEXSLroTeBixQySoBiORq98blttOxV6FnRzlpsDAfnDXMQyubw
wtY4UQcAhFgykv8FibJXVR1ihDYW6aOn1nYgRnPvDd749JLohsiHpHjj1H49PSK7ITQmxqvqKbSP
BgDlQ2E7So77IIbmvhaG2EIbs3JOcBXOfVuxlJ3dtzllcC7SlwQ68PrrVzamHPEkayvDjK0vnvEH
ocfz0fL65rEs6ujL/S+6cYR53GHbkYyqNCbk7/nrdqrUGtHDhSTc8Ho7kL7jAebp3auBWsCL4w7y
Fxj0upQZ5bZYBcflNGt6Z5OgmVHmXapO2mZpQj3ldbfnE3w7KzkUg0iBQKo1q33a4qyOAbLdBL1a
TCd00DVfHcL+lIW7xK7bD0adHQQIfUdeTPBp1ws4105qhmUka4kLSuTmIB7og4vjYuu1T0+g3rkJ
n6+66/uBBZQqoARHss0j5/7XF0M91SnNfmRuVPINyEJNBvhB5VwEnhCz69ttEcZ+Upggqr1CS4lX
rI42TGp6WACYbtSiFD+SKRhjlA1+6BR5ekT0yXiV5OHwO3Fz/RSGcZcemmnSnlhC/AErxJXfRehz
iOP9DbjRsKBayTsFKpQmP/n19XzCUpltNVWaIDXN8Q+FfBTPkat7IKlfCEqVrjumk+KdazxxHzw3
VL9aldXsAVC2dgxcr2f+MjtmzQ0XZdm1eRbjVaGL+B2bJX6TWEbmO2O158+1EemhH0FdDyyjS7iz
Lj97jTAMxaamDmPHel1MI0pQRpcolyrD+DFLTsI2xyfLbkvEcbzh1LFzNavwdnbSbdzFz0A6Twc4
TqdwzYbQoH8oIudNnRuFttjS6yfccuLj2LTE6Jj3XDrL7nc+98ZxIa4EVU3Jj9bJWu+lIgWastZq
Aq9x4fA45fwUGnH7ZqQB29OGGxAIvr/BZOK0Oi8gHREHAUMCznEdpIyOWpShtCKrMwU8QK3OQTbq
yJPXtL1iRbEwfhvVgzPo9af7I8so+WZkmHYASiQyd/18UQCcqrHSoJSIyQyqokxeu8u+woJMSG6G
gSHFXyQQqL1cH6C6b9MlnLwmUM0avYjQnsuHJBLxV23OZv2olMZwjGZKrEmsJJ/GPNYOqpeK9507
ZOWpCYU4LcJwd3bXxoHiEQMdjKg5epfrxqfSojGpx6kMe0v9Ewpa7dGJwLcctJCa3k6eubWVpV4T
/A70k3AoXC0BZfLaGBhMUbvimAsiA9G5ztvOS8OgVni1LRHqO4NubeW/B11l7FZdLrmtCvrsfWoH
Q6fYhwX/1sDIWypt4fRiTTcWUwZftDilhec6b1fVMRmjdHi2Jp4fgJU1fg2X5Yi3EG6azjQek6Yx
z3gnezuH9uYI0XyAQUORh9onEfhqpmgZzDadfagsSuy0F9NsIiQtpHMF4jdz2l1sUyx/kDEFbtc3
rrFT/LzZSiSgRERkayiZAgFbFdLDBXLOHEH77eFK52edQuyT1YTaY2Fr4d6teHNo5WBwWaRqBwXX
tZD83KZdpZclqW606G9hCOknry6cT/evho0VJR8k8KKgS5N+3dmJ1VHURHRgbFiz93FFRwD+YxUQ
Tiw+gQRsR8qVh7ac91jGt4AJJsg1SKmOZBQ2wCq/kHKQZSlhWXPjaj96vRR/CGvtGSVTgAFJi59M
wOdG2nRqTPts9pGG9Hw5pq+s3MvoH7TgL4Mwaaz5WGU4UQIED5sP99fn5kDLH8nrQEkRGBMf4vpA
O26uTUqHcBVGOrpBJXUxTs44xIdoIIJr2sqiAKLhfHB/2I2Pj9QxbU1oBCSB69jKkdhnTwLN7TxM
vxaFKzQqhOYuAPrm6qCLSMRD+5l6KaA1+ed/xXCEF3XDzmCcSU3OmSlcFC7dKTaCsZ7dz5lt5dbO
bbWx42RvWId4gzEZPMHrIVMEBeGnMOQSCYndb7qTG5emXwptOXqL5mFa5Zo+Rcg9fPntoqK+S/pG
SUKG4ut2cT2BhoodCmpR4vSvtVCZP9Zx1+4UdG6XlPCRkB+UDXHFTVgMgW9m4qTtLW3SIGkH84Lt
3I9l6YaLmCjs3t8ptxsU4Bj7BDwXitXA9K+XE+dND08Vevox5OQswCenPaV6F10Swwo/hNaov2qU
pNpJiG9vQkalCoK4nEylbnr81UB2agHtWtpUP0VlPiHsY8RBnE7VzlHYHIqbSSKXyIXXUpSdOVhJ
7IKo6RHs/inKKfw9JZn2NqHe+/Uf1pKKgoS3AMRbA0UVTYwsNZ1KxcbN4GIXVaQdcj2KBPLnlDgf
xqide5w5MDbe+YybsyQQld0ThOTXjb1ZMeqGgi8HUa3Dc2Wb6aOb587ZoBy7M9TtASRFBPvHeWeS
BP7XOwZZNEtRdOo6EPbdc2VC9zt7zTKcDaN2/ziRWtKkg7712iyEvQPNu02ywDlCT5M7VZUc8FVl
QzfGRYRuC4xn0fXKx/RbK+gU9TVi/VG1fB10bShwJDbrDyKJbBRteg9EhVI7g/VSXob8KYh3UOiG
gc0mvl4HJRTpOEksU5q3+dsen8Iw0LLCNXbWe+PakWIhMP9kunFjeB5pwEpBaYO8M/PmMQLmd5r1
eE/Keeva+XsU+Sv+uskp2idDFTOKM/UpJFzMY902BBxedlV3QrN7+HP/sNxy6yUOXrpTyPebRo5x
PWJJKVCBCtSiZZkarU+9r7b9MNOdN0XnLt8HruFXFG+0xJ/c0XjQ7bl7yjwwVHlY5K8cYcCiu/+T
NtcAFQNsGEhyuBRXvwiBhjiVQI4SZawvtlJmr+bU0b7Xbu4cXNyYu51Pu3VqCYdk2Uoq3ax7gVbf
5U23UCQLUyW+jHSuD2E1p0epl/TSNIbVph8HtpCaJ+2Q1WovnbOMtgtUrIYTdlqcInsQs9odEm20
LveXceuCoMEJ75AaGfXn1cGwc6VPugiEUa86mXOw3KT/04mw7xCINqUiLE7EahOrJ7gXyfn+2Bsr
+kzl5GiStIHgvf6ESzLPRoF2RzAgSPm6n2v1fTQ6GQw7EFb3h0I+Vy7aVcZK0QFQrI6gh8zZ1kVO
cOS5Wzcg6B2smJpHZUpdTIhr+rTgfozyQyMUpsk1pC/nRuv7T9DaJwrabqN0vimcND5pYGo/Kqmt
/JjnKfxYNmFo+4ZF3HiY1bAeD61ba56PM+Y8n2fNioZDnDmxSi/Eqn7XjWFWp6bpu192UUyT3ywN
l14LpOP9rEJOC2K7Mn+79ZT+1ropKS8Y+5iZX7fV9A6PmL70KafJeD0xsl+E99qXwm0am/5A5X4b
W2doz/NSJt+kSW0J5NhsbairYfohNg2i1kbHbwoH91YkvoOo2+s2GbzqQvl1sGXACcIjUZfm9zA0
dvYmowR9mu2QbJ2YtYdBj4F0eJiyuLHPeGwCmjdwnT0Jb3HjS+iFHrm+WzjDAfnKQgC6ndvsOKpx
sRyUUounE8If2cVDdpHaWqW4hp/ncx29h3FafgM7G/0omqL/hq+mVR6nZmx+9CR+n1tXE4NPZUhT
DkrY91OgeDp+XmGSV6bPxZD8KqxOKK9dR2gfmsWo9cCInfCj1lTElz2iSQhNigz4easWTvJhwMUl
OboDgD4/s4r5K0QAEcNX7vqZf6ROvuDjPBgkRAiuWmiIUCcbRPu6WBTcORatwJKzt7Twfzm6su04
dSX6RawFiEG8MvTkdjse4iEvrPgkkQABEgI0fP3dfV/PcexuhlLVrj3Yu8Cq+1tMOUMAWjRErErs
YPWTXCEBhJ0X7LAOzEhgJCgY8S1AeEt3gV3bdOvyvNVlwYvhwtJgTA8jxSNf4VRKPue9578NhK+f
oCAWSAWHPX9YpXvvjuOyxKTpolRNJ2F7WMK1CcM4LKYee4IJoYKPMBVwpmFzrkBO6iLQ9hhfUnYB
odaNx1USxG1NrP3YRx+loBTA6KZeTNQnh3ybC1F13SSHRwoVOcgN484vKgpBVMO3iA5sTXlyCRIL
iJsy6LxKJB5zWdIdliqndM/DoF43HSMXlWp3CXD2/4XpEWKqJAdWhAu6FuYMYUmPVBsW5r8T2Oil
h6zVpi8FYo9oGUdwvH7Z7DS4Y1cIS8+TS6O+hgnlnB5J2+KXBYF1F5N0aQDjh35+prGan5BpLNdS
ICvj2recvBjThbBN30bzK8uw0q9iAxbwEXFaYgABb83SS0TbloB6hKESUe/Lth28pj5Cyk6q0x+u
o/iaIt8tai+3qWrWhMHJJg1YAN/HkK3zQbgFkd77ptr/tix3wylR7frfjL3kBwZIz+uhldSVSwd5
78ExF/3jfdZfXWg7VJ6MK0hAbL4kJc1ZkpeTWopXzQI8qbNTg75f3uFk8RjO0DBt4rllEibVFkPA
xcIDOD8i7Bdj4zTH0z/dY7VRumzHmDwiK3Yog03pc54LkpYLWu3pIABJAbPhYtxORuRtXYCWnzSI
pG/jM+gH83B/H7C9dSnZSgO47qVANAat92U0Z5ZS83PZgzksXTK0X5nFU4JFFSfLeWeW/8Vs7b7S
RGWq3kdicDC61EINgZsc1pIWUJcLuhUva7abqYkZH9g54N7Yah0D2BHFk1SsIdSEUU3SDXl6oFwk
4Qn9Bl2adRlaVc4zFNCVcTDTbpZoChCl6UOP4N9WMlrrcJ7Ccpl4rw5wuN76G+cb3Nt1t7m9dsM0
7ifQ2G37UEyzWS5dCHV/yXMEG1Zstft+nmkgkOy0aqB6zsKc4hQ4K1WZ8zCwv3jHrHjDTJv8iajh
CAmRfJkfQVKIgaEPfl78s8bHMQ0lDqAYnOTteI0Uye1x9Qg1esDFh+V85kA4Dypk1ffrk6OWdA+t
D/a2QZZAP//JyJ6Nn4yLSWo05yoA+W/P6JCvxyxdivw76xD1/c0it8Zdubb74uDKCcPb/CMeUlhk
lib1W/CqkrQv/jq0h7Kmg5uW4Bjy1kZBmTrwikEejmINiVUg6SBdOYHYdKfAh0M2HGGKr/lvmB6H
olyJp/5PEO27ShFMkkl1alkas/yhpQXKFfiJxRq+rXaL7HsE53w4gEVzZG7wP+zWP8MW8/gjSADy
PAQ4REgFT0XW/lsIwtm3g6R3ks4RA5Hrn0GSjc2jtdwlCkqiYqVBqccomPt6Aeo4/+0Kj60/HM7X
eXuFd3k3PwzWKPiiDNQjensZV/YJC7Y0lHh8wo3deqNkgmA+ZucrA1QPDs02ppq80RgOtkDgk22H
MsYQ2b8EWPsOrJnjgfQ4ntTaUgkfhpgHr7huIanBOIr1E8XqkgWl13CphOOMT1jiKgyU6bx/CJII
OPWFE3WyQp7mYLvSMWra05oNK7+tY7HLv2Pn726PhuDRvyXKuPQQ4d0A1yaEjy1Ma0LAM/1fgkLK
lnonSNM+c8zMrI7bbLztsV3X04JovLnEJnCXD3QOmGVlMcJyh1SZknP7BF8/Cb/AKPdgZ5STNAXc
eHqebNjNJbNYHxPvZPHIRZ6z0o2bbsHtIQ6+TyXiRovsbdQdbgroZ4EZhnK1xSaPdih6exrGLYlP
M011ch5mm0IZHs5Ff5AZGHBlIu696xwQMVV+3LaQITqgYPwPzf3ObhI0xrj06Qg3OaZ2l5ThtsH8
SQccq8WYOPek77YbALYF+lApyIxcp9hI5FLAaXY8bHYmSaUMjKsUUkjXrqgRBThiNT50UQh99bQM
PyaEMt0PSN/yGrFhISvTaBNPIHvDdhm2lP07X0HyruZ9TYMjAWnxqZgyRsp4DqAU2vd4/Qh9tO6l
gBAQ6RshM+c2jmEQPS25xbKqQ3BM3Q0ZeXLC6k/s8I2vtiSIlhKjT2svkywyV0PJsoHS0am4a2Bv
AXeiLF8FKGZtjJ8PjWDfYwo3lUoWO5tOLvXiisTQsa+JlfPDGkQhf2wjOrnG7y1/2lH3cOHAlv2Z
xj1FB+njIaM4q7D4q9ZJCWwkcvzbauw39AV5n4NItnMrgVAt8NWD1w+CJcop1Dr8JQc9mpKvxSJL
dIZUlUWbS3JACt5eHCm8LtLS6EnSOl9nVOZFKjhLq2jTgGPDza1vclyNOnbd6M03OsU4KQlLRP+X
B6YHVwThB+bYasjA7I0ZDr60Z974oIScwKhPOok1zA8eydcxLNvadGmUzoxoVMSK4Dval/BLLiHG
MdjYK3cOzWKwbeYapEvX9V3ehAiZD0rHUzVi7UPj9WHSaX8K27SbLjsy12gZweRse45CE4Zot1Mn
axa2k28yDHDLg1uts0drVbyij823EY96vyKIlY1IwI3GAkhsNlq/llm0G5geg058Rj4T93UxT2nU
7N2ClqzE9LywG4pxNNzgzs+H524F4vHkZlgBNT2Zl7laA2pf4bvXihPIeDlkgoLLSrad9MekA6x2
LXAfj4nwKZ6NBA1vA2dQOzzPmSMEpuWKXnQf+L+5BJPRqntLOoluug3puHwIpDLpMlchWhQo8fIM
XFwzZiUlHfimgLPFN96a9TuF7iIsY+VldpV+lVszh2P2L6Mb0w3JjBovZJjzf/ueaF4zFM/rvMCp
rWbZQJJyRG87VlE6i662qhhfDcrES6LVGtUa0BnO6bGb2hsSCMhS6m2AqQu8fGNew8gkfoFNNQzB
0RnPiH/C6XbWPMZJK6fetxecwwsMCfmEBnZd2N1ALHf4EDTlyj4WCAh7HOTdL2pZgn0oUVLVXPFA
TYiz6Eb9i8pxeEYtpx7b7Wl8t8MguiPeBP7ayhS/dMsgw6wsSLuQs+2BWxAP3MHla2eICGyy1eHP
azgfn0AJNHmJnbJBMsxQTFO96ADTF+zVikqrVEAHbdvwmXd92qOtihA3t1I9PzC7h+MH8Dj9u23V
DLbEHsnlgncyP0IXm5KvjAvGT0My9n2JNJD2fd/7XZXUpl7XBRNLWKLB636tmVoPgSomWcY7iO1v
4PSN/qoTGXQVcN91vQi7ye+dFB4fGIJB8FoJpwZmPqgCYz8X20Hlyy4uWZf787Dgbr3MLeXXaEdl
bNwS++iCV7OdzgA35rFMFFJCrmbzSh9pgn3BYVATwhuCApAPGod1J82aI6T+U8dmmD4jE2ZTCTe1
qX83Y5AVVeDnpC+HflKwJplI0YLYpNbfLBDgdGDo6bukGs0m88oW6O+AWMdocGElEfvD3gtDL3wh
wwDRNw+XT3hjgl3C8q79jFFb8zITbP+Z9Cv/CgdvPqhP1DtEQ9PNjdL/xmKrF2eK0mHLbseTXMdj
uo/HdubTz5yvLTDPDhdvgrXP+jvYcmJKsoDFbTJF3xXPiv3EVl1803b1+piydk9eiqVP0ka5OPmv
BQ0vq4t+SukZZRwlNe3QqS5+ENE1zef5yjM0VSUOCgoiq5Lhyz5iPj/B7SYiN26WVZ8M8stRZPJ2
nh6F9ttwMonso59wS5bLjyFCv3uVe2eP/Wh7CabAHlxwJ+1/iVe7PCbBbKYfIxpTck22ZPvHwe9c
6kVAClwm9G47NtBZz9U298iwW1OQXR55J5a8ieB6GD21MQ2GM1KN6Z8wtMUbFvZ+PQO76OLS9GIK
HzdEQZ1NN9AWUu6E7sddkxat2JqK40gmw07dHHY/gn009iGb4tWcMKe3Bw4EZr1Opk/P2R7NacVM
7MOHEVcHeeF3w7zjZKPpjLVr1p/ZRMgbYUqguSDrANI81rgfUegRhbbOAGrLYAVwiKUvLDGaWJN4
wF9PR1FCl42hYkYY6edmWtVDT49ntJdhGzcqjuRLbBSZKpyZwYNa1NLXJieIQUgU/nAJM4/lbzwG
Lbq2du0SUJ5Ft6G1XZOv1NphPMeLhDVRmy3kEvO1zyvIRSz5YfVGD0uc0/aY+jEW5bJA4dTsCEk0
5T7iYapRQVHc0P/Z/6KEd1M9qz0IS9hddH/nfnGs2bLMXjpDF4zEImIEWDHiVu1VzO18NwFYgQyR
rktxoMz9NB9Ch5S4I4a8leKLB56buYwmZAghUIfOtzgNBntCEgqAsxC27SgmUGAt91xk8QABVvrg
+jEPyxDYdPTcz1r5AzCuOD3sWK9/EFvErlI93DcPIUACdon7afU1zRhsSNq46/9OLaztS3gDBtER
r3UcHXf0KOPJJjB0PSfMu+6hd/aeQUP7NinFCudjzIABpxXFPVInRXh+3ByBehJVJ4J6AkZJ6YG1
G1cViPqRf4RH5r42UzHH2/saoE9sPD5Og54VunUGHgW4yxBbccBtGHTwjhYshXlZCNhE40+rsgvy
/JVF7ZRDocRGXrJ5A8hCOYPSPhimNqhi2Nk/dQGi6MsBUu3lKeEuPw2h6JcaMFX0A0VcfGau4EkZ
22T65kEyXugWw5UqGLtwOEuDPrGMhtRkdT/45KVf1+EXPu09FWKICn3sAU98LUaStxFv334UUEeJ
Bq446cdUuE6VhJjlcU1wOP0za5j8hFs1WCog2/e3je3UYyLJAPsAMXO/oOVJEPa525hXpo/D7hos
uFgl32dzljMBV6uF1uh564cwOPEFysVrCvR/q+HWnD1MEJgM9Tx1hTyAw0Ze6BgsBSjGcb+UWRa0
C4a+/99bb4rgD0A5KV89jaR+yhMkUzZqS5hpkkRTUW9LpF9TFIm/fkenWsE/bEzPROj9Z7jAsryR
ILcXDcVxE6H60/1qIUPEk4/35DhA3xn8nKdh+/ZxbuZ6FZyoQ5QYAT2kSPzTqqQW5x2ixrXE+Une
xyj1rKbjxtsTcUn77OPZ4nUKA/TIJghVPe8cFkow+oQQh2sO4QBZLbPl5ldFcFsZbtvW+vxJ5itg
Qzw+a1wKBTJL7WgencwOq5oylgSApJ3CcKmTAboUdGPbBGraMLvfO7i2ElJ7YYayy+cOiOG48he4
zLcDzLfQQJ9gJAwcZ0j18LzKnYDMQMTytqQDOGUgIK5LBakSNpodX+gfzDb2nAeYH0tgCfI4djGw
h2IV8/a9FrHSh1mHRD5MKVuC3x4pgP+KpVuhchY8ubaLkH8ocOCh6Z1Jfm5b25193DLRoGWAmi41
HBGxFOjhPzIAN2v4tsDDelHaqAodGfbvJe7+sL0sc2z9YYVGaa89KsU5QTMtGlhaJG8FrCywoeOB
fi/IZF9shqNHOOBElWJL9DY7vieX0UrxbJ1pw5cMTcF2CEKDbabzlC5HrDj1k4jx3JQordNT4DE8
NolapjPtQE6prEcP+Zja0R8NuTv1AI8UYxPzfv2IQXvWZzisipsUup3KnKXrfowCLU7UznF3Ge/U
EQw56TgD7BIzWiecEUtpWzP+ccDOHRDmZYzBjyJo501714aOmV/b2sXUflCErYpyQOL9jyCDcLH0
loaPCgGSawP7Qvsbvanoq3DF6Fbn6PFFBUMj+ymLNv0BE8N+PLIhT34uNAFYt2dZ75Hh4AogwDNM
87a9u9/q2KfNXTn9dd9y8Er6qU+qJdj885SMGOFgYAH3XB+2wLe1Z+pHBGZki94o3/AiyDE/UJO0
5rZnqmAgT/i18f2W6dtGA3RMjKrhEW2NQ95x18V7bfPMRGWxz+xtZpD/vw9qGHGZvAj1a4gB7Ase
r9RXkiA4+SZdt10TuMGkeBsUPhtKnkxIOSD34p+YsVU7OrfIG0RhmQf4j3iMJ9JleOCAM8uyj/t7
M82Mmo9s0rpBKwfT6JiA23mIYcD9uoJVNj2krGtPGifK6+yn+DrH90CymG7QsoLZ0/rnAMp+GLUg
qKm0wDPhOhQGMn5kcC/4BjiYyjPm+PTRqzljJ+MV1JQQeJFf6a6G7xYVCwA2ZGxXF4luLtFw6XdB
OhFgZROYx8zMAV59BGzALNiphFTJSDtdQ6Ia9mVoRryfeFUL0+QBvguAV5tfHWV50kTwDH/qJ+Qe
P8F1HPiEKzahwEzQNCyBOCVBGXPq3+SSorNQzoHo3AYE6xcdmBYe9YmPKhZJyUqgHnh5MGkBA0XP
6WBMRRCrgvYBO4xz2jsZAkP1cX8CPr2/4owOonpw4Kk2Gfd7d82iu/LWom9TNyCUrr/uc4HxB97B
sTyPEeOkTvvYPbW9H3/1Kl8PoFIgAJVQhBveEt3jssGZrguqQa7CP9qRjB97ig7sXYzZ+lvsXZq+
CEI0YgKhe4muFFmuF2eTbm8MEl/wRrWkS4ClTtkfMRQsKrEjm/kjBwv8cdUaKxS9FNtnzLq8BwIJ
Kz0kuPu8XEatHmQGuLYeR25vc9vv2+uyrx1t4E+zgBJAmMTSBrEyF2YHLn4Wroi3+23NYLtvzPxF
cjXy845JOGgIjPjflLU7nljE9BTfZAEYxywAmndjBP2A3hQfuhtZivVX1tq23ma7zXVmSStPCmpx
+yDoMD07PKDuQqRsf1Ik1yVv0zzmquLYONuvTPbLBVnEoLz4kIwB5LyxBT63LwXSIlHzV/RL+Cqo
KAKO+nA2DYpTC5g4OMEEiASPogPn4PEOJf7OepLZI1sytCW71LGv3RQupjZ7ursmCHryi2yrDsoo
KCZdtnZX3UEZLM9qn5DlHZBOEZzWwS3f0YRNxk2ScfmTrWH/tIqdQJwHemtcrbGDdnOIrJFV3hXq
GXv3HjQhxouzg21Y/DakHfZIsJd2Ww1vi7z4sFigDScgyna/0i7Tr2LEwuxbJ9vWVzJaZxT6bHS1
wBTgMP9hAC93b7P0IS7wPp3Yjsjua+dlKgE7Qjt4djDZFm+ac9h0oIlRHLsdDzhVY8ArqoHvpMNV
zB3A7Gy4mdQk03Nh1vkf0r8TCe1TGKGajixYTivWgvKE/FF8IZz7GpcGxLH0BL5J7qoZAvKTC9pk
rgtYW923R237gG1Pinmgm4pH2OcgDH7sih6uB4VS/0iCiaMmsNDgTea3zN8FKPMz5Df2SfVisZWE
3WGLE1QivCLDdgroN4rqVjM6x6c71ws2/jLfuh/YsMKsDDvy9r8QEztE+mMeYJm7ZouvaBYttw7h
m0vJo87/xrYX20FEgaZtCfNRdCpgkqJnvdtPPswZrOJPWg79R0YLVI6x9+w/Pc7t2GDmxg+bJEOq
J7y0Y6jtN6Dnh36k7R+fjcvfpFNots0QdejTp/Q5gdejuqmuBbSuJQkatJMBP6hOTetzuht5itDf
eaCPIp1LzjExHYC9p/KI75LHgL5G90p2sKVfFOZvddytCd5BwXRR6XZVRMcuRq92HmDzrssh5PYH
xdalh7rdQ+6OOd2ZSnmPkQVo0hoirSxCHfRaR+6TOKuwRywmi+GUCqgALKLBLUTxNnzZuM1/b4pH
PXT69+djgvBD1Bbkaqy8vYkGWJHHxWe4eB5hk6HFf1PUwv55DuaVVHwMs+NOdd/V+JX9K1OBil4h
mJv20sRa6EOxKKLhIZQ7IDwbwRphmGyaHbAuS3rA/CEUEQa8LF+mcyunC9ZP8EREJphdDlR2SVgP
bGbusU1i+uSJA/UGxSn8N+lcXAUI39tRhD1S4IbMZk2PknKHIkcF9x3ktjW8gM6qkouJ78ZXBBCW
3FZ6HVIqgzOR0dw3yPeZ5CNGT7aBCwUrrZqM2VBjm2flpRgoNs8xRlOsqWm8zw0yBgoAyCwAMLeP
6+8FrgxY+NJplQ2fYoVJZYvlWE67tF8wcNA49ywRxyDYmEd5HZPuVHSs15eknQiuQ3R/YIW0rM4Y
Wq9zCqptV5Ec9tB4blsYFQFHgdEAvMSmpATFPpuRwMQLWw4zL+JLgQMKxBHi8dIHE9Q+jVCbvKmh
wz4SVBJOSwwm8gv9M8ykMKiLrIxytGT15Ob5ZeqQXvvQmxxTUKBTxDLAcpscILwZl9pPuemvaark
2BSspQBQIAWFaV8wuGuAWMfrrA3EUMsaY4WXWA6RvmZqm084psKfczyGf9PYwSed3zmpQHLg3HrJ
RDTgeQtaO1Q5BhrZaEb0od2Hafqyk0ATvw9peNMrG8GBtxMktUm8RMBXA6eXkkKa7co8UcEZ7iDY
LCQmFUkJliZ/HbpERAdYaGGXhfZme8AW2/CjjhKs7XzE8NNMg3ZztmDsBlXmklWWHmbPCzacbn9h
WEbpSoxsw39od6zhiXfbxY153x3QM5sMGD4y60rMWeZcuCHNK6zZBlX60fuXfQCxv2aQAtGT4BBg
nDvL0neF/eTF+NXN1Yw1PUPLtBlxcHIKglJgmMgwVkfy5whc5X3yzqdVYO7shJ1mYq3bTueYp7Gy
V5cAC+pXhbYp+YlpUMsfCbEq/wvcnYMhkHdY3owAhGwtDI+A8YB8iK6Xmfl72BYtj/ATgVwNQpb2
3I49HOO0G5LuTCKLIBIwN1GrsTVv3b8s8PjBHUPQK0gaAv060Z6U4PqEGI1UURw6ytMc9XR08UkI
Obz2THW/2IY9csX1zMBViIrdV90y9X+x04iwYPDYxXUo55bqg/NyjWtgBeBAoB9fkVOT+wymnsVa
PExuQcBdzpUDIWpMQSHaZym/MSmgFfA0F//N2Jvtpe2AQjXRGO3+wQ0DaRwS23foXGJVp6C7yzNm
jU03gkFTUCNTMLvEyZ14sHPU8grMC4cTLuUWm3KZTmEl5sQvT7OD/wOwMeTFlbNEaVMCnIPTvs2o
13TJph8g76jkOYxxn35l0gt/2lDLaanDnWevPZVx3sCzBitsKzA037D3QK3DZhkgXKyTuCjlAH+1
kgHmwtuaiQkwCxx1gLwJ8o7NEY7+ce3Z8p4ZlP0PyMkFRtD7mY/znbhqK1b9BpJ/OzTWwN6sxmWW
H8ps+fbYTWHcn4GyYOs//v+r+JCKBDcYvc4zgthBNrDS9x9OOq7KYbTQ2RWS9eqKzKye1NPm5dla
tDx3cvVAq1i1EY7aJcg/E0AZeLLACxkri+SO6RCNCY6qHP/ztzJpaoCq0/Atm233J3SgmZbgm4Tf
s84z/tAuCqFxWN5l6yFyUr6ZxY1/qRSLb2Dg1Jur3MatQEgZVapBXBlMef0GX+BLFGn2bww05RWc
o+e1hIAxfMEMBMb5Cryb4dpjyNpjCuJVn0Yrzm+Nkl5NyCoxDZzg2H8bmFBvyI8MgIrrokWCQqIA
Qy5JEsT1UkzM/JK5nl8RPl+An+Q1EwckTsfgFfAuq8cZTvQwClHKhXUYLeAPeFWsSMJLPO+uWuSx
LfsB/lo1YRrgvQI0efUgAoBU5Gz6DzRbmPzCaV39RCjbAv+RhbrXMZNRVOLsIdhcD/BSvHqJkljn
fs2QOAp4uH1UiwbEr5UN8kYmWWB+bfsUJtXeL1v4iPV7pJpkkr5r4qAVT1RPsQVSJXCKtXrz+3Nm
giyrl8UZ2AnaAC3DMizJY4YgMdfA1Wrltbd9ETYobzIsOU0RJ6OwrmlmKhdfrxyMtjs+664T1VF2
2N0eJTBpU9I1U9BnGfZ8TrwHO9iAgAg2XPPBgPD33HZ5gYK9yQxGX719bUkCrhcpwFLdgdNAXdKq
zByKYsmf0IbMX1h4keVG9dCf1jC25jQr/Gr4X4jhFiXzPjVMSfkUTEP+L/MCXQIWrhQOcbA3fFrQ
+n5hWTCnJZQxINjABjxWlZI2p2XKQYA4twkQpoDB0PrvQLh3ZQ92CLajRtqhRpcJ6ov2WIHIUSdd
o9S0h7CL3bpfach6ioVHiJGpBO8GPWgowfVuEFiL8xphOCs6UYFlTTOlIwP5C+v8FwWZUVqthug/
rUMZe+hh8B/XbSSivZb3SRKjbL+hsW5Z97RpOy5v3QB63zVAnN7bnUPqS5o4f8qAKusvjLP6G6va
kdxW0dqxBmumTZsAnevVz9ijVpEJ/BWuVTYpwYco0pID39+u8HxaXnmaIhIMTzJKkFtTlD9E68rb
7DNEjoJ/4US5Gzf+ysYtHS44z9Jv027dzcEj563QKoPXuEtBbwddYvgJY6q9rZIQiCuYTCH9AYw/
WR95hoOnlAsvsnLbsv2P7xJA8jDhYf4kYj48urDvwJLCLh/AxqJBh6BK0AuadMJrHmEDUruMjW9m
R8T1gY/xEj71fEflwSy5/Jmc7Z/GpYUbIbbKHINYK4ZDtMoePjMhkNgPN8FDH55TSGcGAb51t9l4
s/yXzt4+bTHZ6RHNfRs1a7vukLfBA+KXlwNilCP4/ANVAqso+i8noAk2w07m4z0WA8q0kXC0fqYo
eIVSZPRDT5hdsT2Ao121Zx15kkG6/caxa1w14AG0TbxG8wfr/QD+kS4AqUxFaNlFDpvGxlONxS2S
W5ZUrqVYLe8iFvGJFev0E7M3LA9BXWNPKAIqrzkovd/S5f0X2RnA+Ds49pGMir/17UzyigEzwneG
Pc/d5mugh5YOvGtyH7KfIuRzdMpWUI7AHhItK2HBg4LKrFYvWH0UZWsQAAziqCYAn1Ad7+0D5Z9i
64RuBlrIt7ZrURTAGEh/gAsLIleE7/c86rRIUSpYP0IVqBL9uI0B+wLAivDcsOtm+IkWEmU2Y4O+
kMRbV9m5M9sB3nj2L1A9iDdh2O9FtfVYcDeIYzMZjGiyYrnPInn4MmxijkFXsxGHbXow3nwxkM8N
gor4stPIXDC0xTjTcKrsxzjxxD8PAL9+99TZoJJbjqkCYybLDt225+8+zfL+ZjsfM0ywYvpKXZBv
jc1wSVBjO4+ppNNz2OQuXwH8cNFvp34rZihoGWFnYNH9dJiirH/ICIjG2IkLHKnCOaD83ov4d2CT
IjgyIRi+TqHixx4gc4Cn1Cyy9pwS/B0Xx59OE5EdQeM3pxhDwH3cX9QPaoKYNzpN8WRSkLC+1mEE
LGoYmcAUF/ylW3LGKrVt6X9jloNxNCJh72c0TtFrNwR7AJZcBv8eUyAitlI5Wo9DAG+Vr3xfxX9d
F+3/4+g8luPWsTD8RKxiJrjtHJRlBXvDsq4sBpAAA8D09PP1bCdYUjcJnPPHd5Ix4ngbaz5e5jRn
BcGqUvrRomT9GZGa2KMfd1yTg7LBXY1m8LNExdcdJmicBHXHjXaGlLO4GDuMc+i5mdpKFbbLFnFW
zlis2vpKfdaktv3gV29hFnjLdjLJ7BzX5kb50/UzPjdoo+BOqNl6R8ETatQIHh+UX8YRlDF7xFMZ
mZxe1jKd/o5uxWlDSJO4y1wUlodpmQR1XWme/86kdRHQOpFHoFRQN8vGqWDeGR5JjmrzEns/GGnz
2SBkRJplvJp+oVCTLTMMNHufAEgHTnlvIF90rfLnjMcaLXnpAFQMvRJIWsJYrcR2Bf6psJ6rTp0X
zY8xlEa1NYh9kg2pKXO1IVOm70+z4rLf5NEC6eKGAK9PicycF+RSiDLywVRv4whHpzYjW+uFdASp
0FdNJXpn4zLvFoyKEEdOGx6Jrw6XnemTtOMfzJHToX/Q60ajHzabos/aA+B/D2GYLkXILjHm45+U
mKn/qjBL/qEHSq5BHwEkexNzPTqdMk53IrWF2efB7PtHn5H2yy7Erl0QwdmzJRjHPFCqJf+bOqdw
HxBjRCPF9nNtHwuvFc/wnVpt27H3n6qpk+1l1F7zR6H3RnIVutS/Nc5kH+ghjKeNtEF5h8jEdBS5
N847DGGB5Bhd+tZvY24Kf2rqZ906ydekS5P+h9gwMIcKwXkInzlV9+jjAR9bG6bfehTASgHKsn2P
f5TiD1/qcitGEzonuYzVin51WdUlMtk8H5vBa5pdj7owvIMMyZ6sgP8/zL1qgeGDPHMP81BB7jtd
Jw802ZTAQWytry761/rAYhEf+qVw58OtiQRDyNqKEcWahViUkG6k7wqkIC9jZ+ff+aDHRxuLvD3Y
zHYQBHHfZXgHXdh0GYUhSMDoBD3mWj+65hPSv407pJqk/5rT550Yddl/kenOPbc0XeXsVmRt8j4Q
i+peoqac5o3bMixQzTRKb2PlbHdxx5K7ofim9DaxgdEm9RvdxaHNvAQmpo3qh1zcSjoRxbkHulJ8
bA/WLNdcjRz1dTEiDet1k3+XWKJjhm7gmSvPRbBXk+IshIBtfXTHHVc4ye/1QuJ21H1NvsBilOmp
D7cxpnVAH0HPBLdGJ7s3z/jAOiyqsIuTbloUck5nmiPtdFqeMpqrX3KKdOVdH5ZWMVNX0xWNS/u+
OFF3Xeo88ACsSo41t8MECSW1TLO3C4NJeHvaapLwXtjJVUfj2UmdSIV3l50yTMIgTQDBG48SJC5s
7HKnLkLGjZs4kAiztCe/WIpCvES9Nw17r0T7ggq/ICQPpWVxjWoHTqhIioonQQTzfaOIatsjRFN7
t4y1Zt0VLb9KPfe/QxyLh64dG31O/RZWmScCPnzi2xiehzZHiNnXYXufttwWm9xZiniDcLTPHsXo
EUPSZEuYPhUpJTd7aSkluE9GdqEt1R1pcDZ13ijGjbged8Ucs41KxEt30M1aH9lg7XNkQ/RpeYi7
mtgi4fdnjq3BsKpp/U8kAFvo7Y3hIF9TobYRaqbsEFFkhO6kdrV3tqATB0YPTpKR0q9ffVnL7ySB
J9tTjsbLm3SD/XSA2QNOQxa+DSrMfDlopGaUz7XVgFbLG+s3vyym4tDIwPWIUuRy3TtFG0FMd+PE
TaNyWt7jqhXvK8oJBvI0LkA/qhlp/4RugH1CI8wtkecCmWUW/r8QrtwtY9ZE2ylaxkeSHtp5jxW9
7LfrahcIgtGo+l5BHuF1TP1K7+RKu+tm5XOfea/lMu8gX9FikNrgHEdOtfEwUJNTHApqLvgZ85Q9
hPPYgk47bZFtOncaP6pI9c+T7g1rI32lhCcivY+gLMMRpLKR5bwNpG3W88TTDJjbLNlnxI98CoLE
vDYDqTJ7xQcBY5iMCI1J7unbSwBScg+SZYkNDW8pCz5Xx2M/URV4EEWbEN+/lPO0Rep1S7edXbfa
3Rz80Kacml8JpoFgH7dmknSG+xXruJ1pyxGa7thNGWrEs2nIoYDIsMtYsUdEUR0aHEvOTFO9OmOZ
9GebRe6d8q0AWvNwLg7oHsEOIh3EVzfBc4W3YapeKGAfYNgSRdKbpKecfT+Pv2Tm6vgAAM1/l0ku
1S3ghHk1zB3ZJjBp+QigEIl9OUeBfEyi1r5OKnDnjyoocv9saJlMv9QYz+eaAF8Hsj4r3O8Fpqx/
UD1pWDvU72G7NZ6szTHzZ3n0EetX/zzRTfGP27qzpmtCkoFa+YNH/bfo3KegFwB17TpEr2sfNM17
zJrcA8eW/e1RX2+PTLuQFVw4vTjyWwbLCSeEvdRBk8enOKh9RLbJ2uw9ELF5jy23qeGeiGA85zic
Zv6eHrY9A7T7zHPF2eKgrP9Reeh+EyuI+IiAnfgxw74E1L7cApIroKb0aCdg7a0lfMZA09YWGblb
hR+gZ16/b5NWz9CwY/SdmhY7CbJJ1NMegujfpm3dP1nfp/F9X4+r/Zi46D65RtZ0F8Yz8iHUHHkL
qdPEXzhjgGn7KerLh5GNNd9XHpmAW5q7HcHXIqdT2EIXoYgqZLxTXQfuoYbWfe0LOM4jvwxKSBaW
9qNGEjzsQHP9Ye/TxVTtWQTqfwPuxOrHiTP1LRUKjmM1JIHZaXp/X6IStq2ixB5bHrBJZKCai+Xd
5bGm95cQXraedF0fK2S+y4W3u2vfyzlBxLWZRj3+ASbpzDGEIJ9ZUEND62CcLOattrlfEbYcRZap
NEZbH65p8zdrQu8u6CcgIioZMKg1QgDs5RNosre43nJFglgTFL/W9sUkCqMHd+d0UeGo7GZxGiSS
MIa8qz1JjtUmsDVnT29N/FTE9YyU3cnF/RBoI24PjIHpceO1kts86NPis6mWvNowQlLUDHvjESxU
8m0QApVfSySF/dmMSYeWnXob2vWEYg6lKqtnTG6bhUjBEIfKRlivX5hYAmYLfgn/aYZdMsexdOdf
vFz9eKoqU7nHnIvvBFOGkMp0xr8nydRbvkbog2zPh4xQNCSWGq2Tte1dKok02XkJ+9B5xlkYovhR
Jt/MevZRi1Xeuv41IX2Djz4FV9lxhKUL79q5EYe6whd+8ElD/Z6wp98DNSHGnkGA9lF1Y3r4eF1I
42T6/1FcjQVYs7Y/xhXrm+yRsm683pavIUFX086th/7RWcJFH1VcA/8pZ2oI3I1yMLpg5UWnjBu9
wI5KeT1vJUF96kslQwcG6XXZDyCLxFzid6M8dAOOka0seciYcGT+WdQuJBoz65RuG7WCt1QJuPM2
1whWLtMCTmTJ5UHZQEI3NEMLLs9eWDX1qYLLCp56YjofMVmoYDOZeLnW7Ohcya4puLUHtzCbFVM1
01rY4J0sQRPjh3nE5IHRjgNBdL77gjBirncet3NyP7a96s4LZZVYy0IeyT371fzITFrJTVWCG7NY
Y0QE+yXKGA1XGtgd+luXyh4DZLyTJh9/iYqR+eLJgkUpmJzs2nJfnt0gth/tkMHJBTFCmwMrNgI0
IzgpDpnjux9Tz4i2aarOvkYY8p5wvoOfqDGrfztmzH65QMjgcIuRett1ff4Ntsc2JY1jEZExE/zn
BqCrQHdM8lCu9fLUrcvIQy8xxxyFq9x4J7mbnoFdIuBti1v3KEQWvS1BpZy3tAoyxuEmER9at+un
Zm5EZbGWTF1jNBPT4SoylJ3RRVrYe83wUPOg1mRE4X5kL5vi8i4n9gHOiN8JUIJu0gsoSeQeQitc
+1ZHTZKf3dpAVkxDU2AZKeaAAZbJDlLklt0Wd0n5ChiZlSflyuI39hh3BodTPfxhhGXpwBmh1KNq
3OihpOAA/Sgphb8aqZxPvhq1bJHJNW9k3xD9rIM8+TfSiPyje5fx3gZtEO3MKvr62ypTRbcT1J80
pHHrvvU+FXwXtM2reoV/j3JOHiPAbioiqr573kyYuizuGH+rwmNQk66/JYdsRJC1OBS/j0LKa5aM
wfyC9Da42J6gRhLjUBaclGqd7uQPAPFMr8KGB1CEEsX4hGIIKrVKYaT78Mu4Qc09Q2JWeZLFZJ6I
PsLgWeFC/zWUrvtfMOTLZcg9CahZw50jEVznp0nL9hm5Wq6BNUiUeQ6LsHsraUp6t03dB1vL3PHo
Da6TndrBce7ReGbmzVf47nbSqccT9fWA2E4zVi9MiUHH15eP/gY/t3sVnU6Q5aY8QRsf9ImEgGh2
T0ljE30MynzpjuHSjfM+ryzyUNGaqHpKqSUtfwc67dNHgIF5vO97hstdO8fHlLLW2Fj/T7hW/iu0
jjswcw9LdCwy1y9PA8YGfSO7/B9TlhkYaluZZ+AxWZwQNZaPclnH4gnwQRSbco2nfzWhwznSTtXM
zoZ8vtIewtJLNDidKtftkCXc0ErhDtu2YRkmx2UGaDoR2pO0+3oJwmNj6Ds/FLnIu98+qZHFtjOU
9WwZi1cDvgUUsLOLwNSNwoEVcbdMupDnurXdP47u/NcaGGfce3UFVdUGAz6ZijbmH4cp/Ipsfpmu
OmHrpZd8Soq99dZgP/ltJHddIypxWIl9xE0xg9jXks+VuhRu4ChamhGat/EwunqZF5wxppcfaEiE
xGQp4AoZgLLul7M46gvPBvQPtUYzOQCLbQOMIiQFbkqt9bXOO887JIY6w+M0YNN+J5B7MlBhYNhw
97qMGeKjkEG5XpAHNWHKo44e9L8c9HxmZVcSfTl+ZeBx+mQ2BR4DJLmd5/Or9LMoD042thHK6zHN
wcpcfFqMo/YTYrH+E3AJeDxgLNSIkKv8EHUE4t4UAskvaIjiYcaUU2xU3YX6KKIW8e0YrwHUt2jD
O4/J/MdXyeIdVgG/sOlIhvlvYL0vzpBz8p9fRqgS83EcvzhE2hmNPWPoAZuc/lt6ZSLwuXDobPC4
+f1mWTHE7mr2Qpw8kcoglsM0+YNNtiEHpGyEB5PU6K8kwS7dg7cm24qB75rlRlCK1of9f4wCaMj0
FEYpoRZKq3OAUuJFyRa4TtBzE4FTSv0zWlf8Di2WB6KQIHX9fOa9T52Qm7EdhlYc+8VF0prHav6C
1q66E+K5+AHrebk8rgbpyYllHoKRXPnV4qI07je+M8AxfAr5pXHxkiCE9Op6OxcBOccYWDFlJiYW
Vw/0rT7UKwlgZwIH0PiFnvD/tauXfNi+tQ/wtEDkSqjxzfAeN7zlcXPFDIPYTVlcUlUTwFm4iywf
pyEI3cMy5CFHSd6jtC8Qd1+ciBtnR1VY/zgOY/slSi/8WdpOXtcFPwB0Wahh9DA9/jT25llgL4Ut
FeHgHMrEuC+rHEEZ/UCtzW60RHyjV8wR3/ALstsimVifeKv7/1A8kvA/KJiok/Ta+MQAQG6C0g5u
JGdQ6BCJiax2RRf40e+UNcruqjxS/jZUabGcArP643mqpbqoyC2Lbe6oJDzBfRMBmBM3SFqEdtfh
M3IW3zsjJ4d3J9igQbyEYG5ACsKDv5kSNd+x5ZXpxWNFGu5HJMjPBQKoDHNX09hjJpht98Illm9T
VeNyH0w3CMarpjTZTUMY8o9QvCT/lISVZEeAcR5zIT2nfyGEKNTbMKvSa+E4N8Ati6vHiDLFfy4i
Epf/e5lc3ULkf9gE0pW006yOz+Syqfra1qDZL17ZOeVZrX257jIU/QhclfKAiLC5JFXVyqdeTpW3
AabRf5o0hXYKlYJFnDzqB/cm90bM97jNHzCBYldkrQwxa8fTfIfHEu49YfDwN63fWCSpNiGXcpBN
OO98b5YRlyZVpdt2sOOdnw3lty9MqH8nxez9neGFVLVzmy5Te7xHxYMA3qqPk15SVH1JJ9Ot4aB+
RIwR+P/xPjXZtSm0/8A5WXA462gyd5oDAUNjzd/n3dVAa8FFxnlZnSM4wcepMOPfBDXSt8su+WLI
Vwz381oNn2Io83FfhEZNLwrB967Adotrv6NyUQmbpJfRX/KTq5sJ1jPvi33pExO8S1BU54cgC0Vz
BnNVHSXbKacvv38/M25N8s1SMGoea1lW14RnZ4G36sAaspFmi6MFBCYhqpb11kNRjydPCKze0034
iBI9fVMCH+8mnpLuTz4W4Y2Drkqz0TEVeNsUFrnchJHM/2oFJYN6AuyTygzoih2Xyvyqq5j3q6yw
Y24czrX+nFXZ+Bkxrz7lXq2ZHkJ/+o68fvo1V/RrMGTa4JBi0fpT9eXQ7BCPOSdXDfKv6A0LuQyU
2cBm+fPuJl0OdgUk9njIwrLQO6qb3U8UT/qvE1XDlSei40YsquSlaUs3u/p0G1xJMZmDcy7GDnIF
0ra5kApkXwhCbtcdxj0MKS1RItmV7QnJTdJA+G+IpUyHTe/HNmAP0tFvSLm0OHk89lyBMmnegZGG
8S5HnlcfYlpGR4IeXfXD4B4FW52lvsst5atxh9tBhKfWEAS+Yx5Hjo5kP/e3VXVTq+my8po78ubG
6SBTE8Dgqlo/N7CQQENeJZD1z1m03quKEZp5xsbBWXV+qplafJkdlgigYj8lnn8oQK7Zi+EgEMdl
TbeV2H2p7JRmweW5+M55mhhQ9pOBntq44CMoCuikIGhinDTbFsFI/dWMN0G473PbECI9JMipaDA6
o8+sHmmUhcsKqrkneWYaqUlrmnA9EMm9ctfWlENtCJnr/0zTUP/KBrU0l3pRy+MgM/vAHAxZGYT+
gmxyCLu7DN0oFmsnGxjCA8c++jj9fXxV0XgdlE7Xd9z/60PimrZg9fdRTjPM9gBuq8BIzivxMifk
Hh2ceCUEmE9FJKS7cApdKsFtf4xMU08HB6qRSZckq2Hf1V0J/xHPzTdrcqhOWUuWCXFbnfrs6yy5
rh4n/YaZtnnvgqq5H4la1ru8zsyBBUzgYQPfOTPjIl6SWhOfT0eZOERM4DG7rY5hrJOkW79bHSKY
aNeo25kyyx6IMTH5HShhVFTbvnFT/qJufHdkHl1a/N18oLBnx7lewnE/oB+0Gw1SCiZfJn7z7U/U
CFxthddt3DhlOOuPmmCV/5ouQDjmGG/2sbN79eM0htG8UTrQyYFpjrmnIj9Abggi7GDK5IIkEW7e
y/fNmLlX7cU3lxAevwotvROgQGidRmxkiLJkW7l+CEBriBXc9O28RLvkhsCAyYQZ1jks6uumQ4Rk
HpwFmchjK5P4qzVtgDyf2aDfr+Gcuh9cbq24zKsktoQMYiwKxax7nGFz7CCFiKr1EkuoGLVxptE4
h7ZjGNwZt+PwVsg5ty62/nybolzEOcy1uJ1LMT4AladYUztGukMvsajeAsvn4ArtRKs4uECH2rCs
+u8stiZ/QzRaDOS+GBQnRndkCgmILXz90vaYbvEOFk/UZLYvKIhGrLCsgWJLTEf6XzhZIc+JLsbv
Zl6KeyvGmCiftoke6V+L/L+SxCOE0QUilU0LsWF3t3mdfaCQeA77cYknwgKmm4FsyePn2KUAgPvc
acFAfTsMz43EOM8PUzjGRDyXw16UXfiS3VywDNtu2OxZXyn/MAOqDMxLhXaf0VWgihvdXD/cLEfn
uUHlAarSAG40PT1dwOFlN7B1q6Q8MjFhaQji5TVuyUH9s+SYv8YxFc0TvaqFova+6NW/yQHwJ/nK
Fm+mS90HhdEUhyZk9XBCpJvcI2o30GOdj8EhBVsDC8pSXv8G/eAzEgCmm9qf6+5UTk71t0+wkGyC
JVp+AYiHz73t568SKvT37Dieeg/SbjyP1PviyGIXBqZpVcM8kNQ/Xp4v/1zYnGxjVju8Sn6/Gz4C
D7yTBT5FtrLS/Rx0kvnBhj4WwZta8cePkGdtk0KZGh0h32digsgl/HhbEZ4BNwGmsfdymoIK5Lvm
gIfIveRr7JX6yOnRFxcOFTfaFsiZ472PopD70w3WL9RF47qjh1mIi5SAkdsw7Odr13CT7aUv846E
Kl8Hr3HdFf1FqMz+pYYGNWhDtMr7zdtaEqpQzg+cjUxeSck1feiLBgC6H9jbyd1AcbFHd1U0fwqn
5fS1btWn52qYvOdiIXHx5PEa5Zt8keODY9PFblNCGFg3ooEdYOh6O27Z8DGRwg5MmDhpRVWo/rX6
R/4W9UNNKiOzDxTFVGR65zjE+EsygDA/zu8M8q/fCdQG9EBZED4emqRIdzmpKeW2ktX8pKkN+HCa
ZR1+mYAHhoeWAwB9aNvYN1b5yn4kMSJ1zLCreXMI7PkA9Lm5+LtCP2W55K+BMLV3ZHR07havPlqd
VJnoNS0a0gimslq5H1jzUUZiQRDbtHLFY+qZHiv4jO53hEEo9XAXJoFAs+Hl5inIkrg/eKRVfFBF
Gf/l4w6iU5itLqv7gIP14PZyjk+IbauLlxWZ3gZD5AGfAROQDmXQ/W5XWUAl5yzA4j6tZxbjUQv+
2SWOF3Ht9DLd6TzvhstUZglcmiAwZgucJABJwCAww/KfABbB1usDjgD8QiNFU+UWM4jFzyXdddox
yxLiUSw+L98y5lm4k0OBVNf2OWIAQFWG17bpV1QDOh+9/Ywz6Ijuoov3DqY+xgPwPneH1dJvNqsK
sZUH2nefuyHDk82Jqfe4YAtnay1qhW05rKuPo0hU/WmaYo6bqtZ59V/DlmVI3/H8aDMuU/u7WNZU
n1D5hfHGNV3+q4zH/G3EDg+LSfFjRJmA6v8CWvF5iUIOv4fadeGJsJckGxxF/R0EPfyA6RfSuPxg
LsQRl2H3n7REVRPrIZZsY0uFAyTDM7ocrB6n5zXkw4T+zVn3CtDLjzgOaP7GRublvMtKvGcx38Wl
zkZ/qjnrXJSSDtlzNTIlJ7oIzMLtpawTEgkUw/1wZImvXpeBI3+bI2kzJNqDLO8TnP3ToVZksGxE
SSzcLijS7NU2buU9erqJz4gDbEmRoJ8fSF+W9WmhO7W8osHjkhsQtrqXlFRbSmTawGDXSEkPRKMU
HyEn+/7OI2rN24p+1L+GKUx/eXiqw0PP23PzwGvnaNuyy488o7eT3zo9J7dt5QGS1yImmv3kY4gb
VIfD7KBnGkNezNT64XHqLPKNuvQbcRz1YOPdhMP0cGNvsb3gRr0BliHIKH5Htz3MZhIvTq/RgJSh
MvUuRbr/eyHIK9nVSIdfEKZDPmUYkFGmU9LYb2zrRw35KAWS5rnvsfg4ECdIt5DN/xUq5kBegxDd
W44U8xvL0UxM201gWHReV20M6WzfI5ft26xX8gcQJfnd48QPfPBWPBV7AjWcnB9eD6cFG5VzBbYN
4u2MM31Criujc4Zp1e5qVQCicoZM6QZH2/9P406UT03lA4Z2MFYbD/4xu06LVe7B1j45CWTmBOG/
IQnFg+hMP0HRk6iDjq4aWm+Dozlxt2WW2me+wbGG4FD6K03L6LNF5JNckiCr3BOByUvKKO376i6Y
7Rrz3kX+HyxfyTtXv/T2FhUoG3DppV9e73ivBAawEQ96AvtoUPv2mBm/025Y/W1DxIy9rBnJ50eA
7fRfG7dtcfYCN08fyAiHu5oC2677LsCucEcQRVCyGfjMxo0e+4+1z8Ji0ztCY2p2Cg9Ri4iY4yW6
jPHsxY3hRUrrZj4EGmPBrs1B/PdxRNIH8XtrwHiVZ07ySnoDhow4R5F7WIEbAfqiOTx7wMIt5ExI
GFtEtOLFipxdmQwysg/meQA68N1QcJggYnyuurkK4agt2HeBdPgaCMzuRML6hMZVsEjk+PnO/JfU
lewtiGkAOeEw878gkMjmZG6bSOK0vr9fwOO8bSyGQcN9RRiK5SjJoCvwznCruyP1U9F4S6JGTMwk
mKABVxtigNVPiOVLX5KIoW1bNQwBe2Kgk1uoX4F3k5crBQggk8S+MYXxLWl6GtdduCRe9dvt4mFG
yNYSkpIXa/MUpDRBHmfGYx5zsILmhZhODX65huALkrPh06nRoZ+QzA7ESzYJICNVJApttvLjDP9x
4vKlTx4f9WPdQ1ecGVFq/8yGNcsLQh6aSHMAOdJHo7oQeH0FYQoYtaEE16bjTufEWNdrUluFf6RZ
a/GAndaoB0Dp+HfSQdP9ckiGEfsFLI8f6CD1IuxibbFLBXW1HmNcq+Bntsy7rxQp5KXB0LXcIX1z
12Mw4SU+jqLvx0c41uzR6lh+ucoM5QvCcLSMPIMLsCXuY9aLLqDTxLVjlPwJoAGqCy66stoNTc5s
IfkCNaZPH3lYN2jjXAo/c9/lQmvnSdq5+uVqQ+zBqPWEtUDmeIeEKOsrH8z4lA5al3suIt18VQPT
z35wyrU72qhc7tGYE0C+eH38WUgkh9SNW17bvB8KZLFJPj+qm+ISVEq8uERWYQH2g+rQwQBM0DCQ
Ci8qjxFk4C2Q9k6mwZwcXKdRx9VlNcK363bEVPBtXD2vHbstGWlpvB+rcBSHkThVNPwRcf1YMSqr
zlMg+t+EgbbQFgEX0knNZLHvp4GN51QRFLFfqtToxzQy6jMqV/khiBFkOfKy5deyVpW+82ckdnsG
HOHvcx9N8y6f1zzbGbGgzCwIaeLdyNFvgTZ7sEdsiHD+s/CRFjYq3xZECq3XmVAhe9RpLsMtn58c
8fvmMw+r7tVL7VST84bkmLLdtKK57S6hCjPbo0hmgsaExPbkTZOqTyx3sr8fnG54cuegHfejmcYS
5UJVRHuPNMxPiVqrPCRDauwRwqW4kGXHJja3PsoPiJOG23B1qnFv0669CwLdhmTLJGt9HLLZ5y2O
UPaykDiN/WvSGUVWG5ELiC09FccViWOxYdHwWTRXrwkIhJRGf8xcTEhAPMc0G0xDCkYNnH7GeRVW
DVEYiW03yFyD+YnJ0G+35EQC7gqpo4tfIfo+j72mH7DluwA6QA7b3qEOnab9irLpXooxjx4nI1N5
P83lDEEth/mIpLT8nhwncenwqvjSPH/1zyBqBED5sbq94IMT/ahi7OYH+OCkPwx1M6SX2cEdCKEw
YQyHbjP53ptLTTjWELrvjo4s6MgaG2aAZAEAIkunwkoalwIHQ9TcfGsOPUXCKJcMwRWGEjTOz73H
oU3zieyyOIn2LVnfHAmG+evgteBIpBgR1rcGzvSNgiP6kbrHky2aCityoPVyjxeu+GYUaZubFd7s
0mlGE3g7y3csQTNMbTHnL7qvwHwRdIASur0bVBBvqv9Hhln5Va0KUilj8jsmgAPFHQ6yId1pFGmW
Wg5T29dy0qx5pgiyZ9l5+hvHDkk2HW75eS+9gcbXollBOzzh0caQgICm5DvQ+rcXHBpcRFge3oum
0+KS5dq+r2pdXwnWIJOBufwfBirN4ZNQa0www5CeggFFFwE+6/LLlV10EzgsqARjnq7nISiqU+nE
+RMLFKRUTLHfeKmjgY3plkSmt0SGEa0Q9p5TbYQZveRMi3b/bbsJ26TfY7UnnrbDzySAJZaTi0Oh
fW9rMmkPt6Kwv5Gcjb0o3t0jDubMXGej5A8o4+AiOKP/LEK6YYgkxZfyk444qED3UP/y/uaM4KNo
gm5PUJ1ON32QNce0SnM6oxoQkstcVbUHEbj6YLkR7gWUNK18IL8srx8IruEo1qMkiiEOgIF3Xc3y
eFtnx+wiXMjGveuvid67fUqEbaTw1m1CImbRbOJ4Nw+aN+1P2Kfmu0t0dkcYkIvSeTJoRIa2o31F
G3YcpvxYrvtVFN4zUdDIofq0bp9RTEB7D3zNp4F4MEh9tsU/Lpp4uUPaS7YzabIksK9Z68m9I4P4
hy+r97aKGO7iHJazD4zTEo24zaJaRleuOpsfySgKiyPOSr4C/pfjSVSq5maKgmS4y5BJ3+qcloxH
cFDio2BG6U+5S5K1p5TzL3IzuZ5WZUv/MFd21TeHTfOMChZ8ls+o+af6EIwykmb9aRqi9+6JdOmD
QzG65j+y7It/bDbzQ4nc8TmcNFZAVXvtuxRe8Mahlz6UtjGfKd5Ju8+dVGCbb8Jfxp/8j5xB8j1a
12miJT0nzbYWa0WZOVHYZ4nSCZVc6YZc5y5w4k6ybOB0FwIngGktKc1ZmEWPNdJ7hyO0sv+xOcNo
1lPp/S3Rbf4ZbZD8dtuR0givIgCJtTuPXmvfIpbSVPdyTcl4upKZFQf/4+xMduTGtXX9KhtnXMKl
WkoH595BhKLLzumy091EcKu+7/X055PvxKEIhJAu7EGhNpAMiuTi4lp/s00oUeTiM22y1DvluW/3
u5R6mLGNIDRXe8pfyrvJC6cvmqiw+cSX2vxM6ZxtjkURzyXEaKvnEW0DZA0QcaEdDkTpjeFTHN+Q
xGikSpkaPiklGM2N0/h5v3MUK6GkRn/IravQbmmy05UAwqr1P40xSp7x9PVAPnOFoV7lGTVgOg+j
5a0p+yF6QJ9TvDQdeYHSJV6yhYpBTVPY9N56U2bK1nN0x3qyJ0dFibM2xWcL7sNbED1BsI2BqGJH
mmFSjz6W1x7pkkDtz0rF/oiRqlRdhRxwT5UTfaI26RAgwfJpCPYZNx5YAvB5WxhTVbSDJ0aB00yR
Z/sXCL6AP4fCCIy0oqWbPcztiYzGL/SLBM5RP2lqcwiAGswqAXXCwyukL7ypTfqFaFM0KQD22uhf
sJ4wmi+NPiLyCGRH0Q6JOuC25FGZ1EGMF1b6obWQ0wLnzNhvK6ue5XRTftFYVs0PP0RUh2ZerxZ3
5FL5Q9Q3KqIbQ1/8HC1FPGhUayjv0zR/1GOtaPf26IC2jjmw+gP1wylyTb1wiLo6N/aTOgKj2E1p
qKT7Imntj7wNcGoTFRKMG5pN3KXhOCHrV0ZVg4AMGWC/T+2JtNvT7bya+81+6Jo9LAfXiLS59auY
3stojcmvJiNL/2Wq5Ht71EnV9j4tEb3ZIPyHTH5X0lncGNGUW7ssY0r0HSiibILQMF/6oMjpQdga
9f6Igjua81R5fozWlA4oNsY11rsQYDtsJpvSxH5es36m4P7uq7EWv2awkb9RO94ERB/qEJsWxcGZ
hwSMH5nY0Xmnpn4XP/eK3Qb3YV1YkPsg9nMcK4iwZZ5HUKUqvzmkuZgtLQ0n4f2pTNO3kOIOgnh5
pe5z32oMiju2AWawQVz50SvR1tlg2l4nx16a1LbgqIlq4zWK+S5EQvhHY6GTjKyL07+Jncrzt6Ze
E2G9kPO7NwPgC/ukMkdzM+pF/oQCLz19Bc0WNGUH8dGq9fpbgyo5KBuNNPRgW534GeFplDxx2+ZP
EJxw7K49obY7pfIE4OkE0iIT8CMqoSh339l9E71HEoUeFTJ61UthlBh1QhHqvqPaVeabDrfGn5WR
C89FioIOBypo9nOTWAHZAdEWfbvSiH45HEEUgbUuohNl9NZDTwIMbylo5fcUWdsODSr0dDYJT0G5
QZmJIJAlou9h4Vdw7BxasXdTSbrB02sQ8Qa9HuuHVQP7rqOq8rZa4nF75HolH0GkQ3oBneR8BGce
HDWE1DEjT3voyZGJSDcmdCowEUTMG0A8gy3n1lsAAkPVyzh7I9JC+56DEyhODiKSKbrltfiBuYei
b0c/06GRZlYTHQQI9ifDHtLm4Gje1G2Tin7nbsRORxxA4o1Plj20UFkGXx3cNDaLr4nvh589wI0v
huUMiL8NFYfpBwaHIj2gB9XWGysVvgCA07ZvQywjvGNUxXF4Av9ATg3wrjnZRq4iLAWk/OOQhfZH
G6V98peuG4DCpB3K0+rUfQ1TnWx9amoQfYnBkxOQpPl+sg1JWROpLqiJJj0qmjNNHLyhOG6+KE4C
P1iJjWS29qTa3aJqYIGfSCsLjDF1pzkNyEGovzObiaBYFLDv6IDWXb23usz83PqFBeVcm/T31gTI
EAMFX+wietegN9Db0OhHG7xOOUOBiQYp5AsXiLKEiFnAGaS04ZQKPVcBms3okMHd+Cmh1Q0ohO16
NJtaog3d+20nAYI/gQ1p0DCjO4TatYAYoYVbxnLKnWj7OHnvoz7iIX090JAET+l0OzR44SJ4VjyA
h/HsMT1yIYe+SznESI66DsJuV2id/s2k0Z49oOxPcp1Wyixw1eSIr0cGzhDsM0X/pFa+9d7TG2IX
L5M3ZlAX3/VUnRKgS9DeXF2C8XBB85CqwmzMHwZcUz6kYxp+a/NKyeD928ZLWo8d6hlwsilR+IX6
CU365N8EXHu2UzWNTlgpLAx0HMrwvzJi6gj6LQ9shBW7gqq7mQJnraU9vKRdO3wqJ4Dvih3FwJHr
qbuvwoEqs26IEF1csN4vCZg87X7AjwCOGLnVLDEA5eqAIVP1rHYaG6MHXvd+LPQc08KcrwN+CCoz
go092Cp0xqFjWKA6lT1gIzSmGqwQ3yFF52tfTKumat5j/PUUEL2/G6qvjXsrQqj6UYFpQrV4dOyI
sIraO5XAVLefjSSAitBC5ih3E3627SYKRn10feCYJ26SNkGcNAdFXSuG+W+bmi03WMKlVMAnbTeh
VioxeaRV3Vld6DhulAWS5AS1GH0nh6b7MslR/6AGY6a5NR1auRVdabOdfZzsUM0NR+rHGQQbHQhS
ej+aQhcUV7Dz/hz0ULkfyFPGO7jMWrOvdKr6PqEAuj2tfLTBofbmz+BAeZrSyw1eul4SxpzW1yOX
hpBNad6j1uHylIo/KWh/lFvkK0e5xzYs/pQFtTUgRKMMd/+UPEh4BdFnkonJ7SJyRDu6qkTQ/J8y
cPq+zBJMaGw9FQ8VdiLfdDWIKAGngu5J58FTQKa71L/7DQRUKGlA2dAs6P1/C5OeDoYuEWW+LEWv
gfKLaAC9tGgEfqE43trPZRVk7SNtbY3cPa98773aDmJytXAyTvCOwhTWTRlkm3+cXtfHjJzOBWcT
3dNZcNAQZ3vH+3/UgkpFQWHQDaRn/aBl17xkehTOiROQLAFL+eM/0wSxUXQ6TGCr1jzSWQFwUQHp
Sg2kSK39PxApG0dIL9nllhboW8GleSdi/HeOEXjmccURanZ8Whr8zKZq/BUpEK2Y7Yb+cMWqgTzG
oih5deSIvqONkmJcAqslRJOiGfTj0PrJwwTo7svoxeOpMZro1Z6hUjPoiJPJG4Zw1IXdYU9CIwl0
Mw0GghLPr8EVGApsKOg5fzUUgs6WDu7EsRdWgH40VvgG8X5SNPquaDP+UtqmeuKlMdz913/+z//7
n+/Df/s/8+f//wH/k7Xpcx5Sy/u//3XxWYkYYNENofP6Mfm055+1jwI/R2nL2oaVEt73U6sduE77
raHgFmGm+tfK6pE9x3bjvjbb77cHn6dxtqY04xhSlQYmsBYN6/PBy6DzY9j5OEpkVXQqRIhlJQIe
+9pv4A0aXYAyT5zsbg964Uv1e1BmLQQwO81ZLOM0Fn0TmKmFalVbfBA6ctlZUSpvEMkPX+utyMQc
09BtHdUfTMwWy0jjbGhwPYB2VhT1PpNO5kJgbdzBw1rptbMyVKoqqikN9AotsXD6MjytK1DGR4JS
Wu8qJ0oeB738ZaRd+vT6gXhNGtjSqzRTxcKZLVEtE7gTGgKo5+LnSk3gjUZ83dMPh7N5e6wLFzgm
Y9iYQTq47dkQeM/3B7xbbFhSx9hKNEhRmB61TazntCzADm+wyejc2+PNf+98PzKeMy8XEUaDQXc+
XlQ0PvJnjFeB0T+gBKnsjHZK394e5cqs8PfUHNoUguKGsViqtPQn7nWblBNPsq2XR84eGil6uY1A
EkXvrXe3x7vc8AhuSxi/jibpCS2PuKrAjk0FyLxEtJjRmxaN3RLRIqO3pw+3h7oyNTiXmsl+l3xD
Y7Fg3VwcSENMKKYssV6ioqXlIAvjVxOrFFzzNHhtnJQGRugg/CgQcMC0xaWg4BLAVQm2TkGi9zj5
OTk56Kot9/iaK+OVr8i2wMcO4SYDzsxi1VA+aGY6AzI0qIMesXnhBFCf2cJoa7e3v+L1odCnnf/n
sPPPt6HmwVeBWTSfZaPcKFooTh6wwkqJjJUAdW29iBnEQgC4RP/FehVaXeZDwFQqMA3wdnli9/4Q
HQKzR4dtKqP9X8yMvqlhWabDp1zEXhxA+qRz2IoZRsiHodd918BE7NDU0a+/GElzdARIbCG5tc+/
IdR/HHUkdPG4ojs/tb63q3Jc66PBr/5mUjokS8EntEx9MZRnh1XohYMBnYfSHf/mP0eezFxcTYIV
68jL2xqLZ8Q+6awBW5TW8vuhlBIGHkLDKORkQJx7tHT2Ppm5M+O4i199VYHkazSFPohhlO09XCav
+5vtaQvbMVTb1u2ldXvO8z2rBtQfNE8pcUaCg065sjoKu49WAvLvv7WIyDqNZfiRgv6vpi7SE+Gn
TU5LTN9mUxZ8Uip6OJtmwPCoAHb2RgRJ/BxWlXFPe6x+wB1PvOHKnXY02+0TsBz5c4yL7idg7czm
hQ9Oi/5+fIxClfKuAilm5cKaT+atn7tYH0UBvBpbtr6N6Vj4WUAP1hswRMD+YoeIu9imYxOiQIx8
yO3t/jv5vDWydr7f0UuB+NIzco2kI5AH9OZS+41F6WxbqlZ378ygAMoEv7xKrx5EmAbHsvVWfsW1
wEXwZ72sOXDZi3AMpciIdJA+8P9QnPRClMdrSAAnpMPLlaHmQ3UxX2QVOOGAgy1rcegoukQthD5j
6zVfTOCbB9oyGY1d1GULpIVuf91rg+mzuyhYD0gR2iLncYq4MWZVXBqPma9uc9UoHhQZVQezHxKq
8QZctJX5qde+pU3NgIxEs6S29DR2YF6TRWDEiaxLjeIvDgXgsr3iJEnXTyMeYMBRNGuPiGD/XHBT
0OPCKWBHcSR6UTTHuh/BgpcurBqxLymXH25/k/lqWCwAVGMVURWbah9XyPmGy+bPnyOsBUIOuqVd
gsI3aL7tbo9y5StwLTkktFxQmhCLbe1NA/1XxBC29SgQ2jWQTZGmtoGRP+5vj3QltBK+VS52jS+u
W4u9m/R6B/KO3I/+UHWagsw7FfR3thRU5iaElR26Wg1QiHSUB/xEqtcHVRJqYh1+2gSICxv2AT5o
2Afm1lFy5W1jCRgXYizyB4jYyafbU72ynU18jg1eCmwsvIjPlw60JMzgkrE0AMPHIo/a7YzNx5AF
AXZaG0q/8m2vrKLFzcgSYtNt0s9bDKgZSHyaFPXBrtV3ZR+jCFg09kOl2c7KUPOfWmxLhnJUjbSG
l/PSxxnvnhq7II8nQyJpAiV12CJcGgZIg2O1tusNoT3il6WsRIirM7Q12zJB3ZimOp+WP6oTADqr
CM0mdNKgYuypdIIjKVBKh+uRH1+9evQmUCnnDNsSEdLzoSwFhXlIpyS5kyfeGWUR0TkAg3yEaxk7
G0RwS20lGF2dnWPxquTOV6W9mJ2pNyoxkA0jfL8pdwpSY4/onZiRG0I4f/1zha/IElq2pelkwOfz
a3g4ASrgU6K3YoE1Is+RmHbvqgKU5+1PeW1eRC7b0Qz8YaW+mFeMuHYOFtncQkMzsR1Ck1hJMK1t
gR+ubJDfmcpyY3ICeDxQ0oEBupgWDH5htS3TwvpJ0iPCHjtyo5FGM+hbOFFJ72Q9T7Sx/1lVwN8x
96nuplYlL3/9pC2uMTrnxFPTXFxmdYJNlKSTtcWAVx5bKFH7walf2h6W7F+M5DgIZAHu4aKY49Af
h4KHG46l/AISRQ2HAfhiaB9pIF+xyFv5vNeOvZyfZtis0fS1F/dEPVTgs2qwFAWA3xMCjbTYsLNy
Kxo4dyhJKye4ivZfnESeFhByCdqUJ/Tz+TkFQq305uqt7jgFwiBgMNLAUj+PRnpM01L7dPtzXp0j
vSNpkF0hcLlYuByqg62NCDl5Yd6+laERbTHlmY5IbMQP0AbxoEC88PUvRMK2PuOqVDI6azHHCU06
wHVouScAVdVdPhgpIMFGak8OY38zwyD8/Ppp2tJmb7JDLQLd+VdFGs3wBoQ9ttZo1i/DhPJ4lYNl
jbAo/dAHdvLQ9sr44/ag1yIBxWUkRh1ecoa5iASiymRp9EgnQJAZ3HxUxq2VKPAEaBUfXj0UJU/K
MRQE5/rP4oviuD1Tz2ggwAdW3YBC5QNl5XiflF63chlemRW1cshPQvJcJL05/5TY6AEv6ep6C971
M3ThZltFibWfQiQRb09q/kuL6Abvj01J6kQhRiwWbRCeV8eFylEAU/JU4WI9QP7MMO28Pc4cJS/G
0Xn/QqATTGkRRW1ZZnGE1u1WcZz8hM1QDPEwQ6JgsuSL3oFVKLgEMUSQ8bfbI8/BajmyFBaAEhpl
FqWg829pV1lr+lKvt74w+3cm3+AtUL/JrcF6ueWYKSt11iunXVIhoC5OZUu3l8ETD7jURq+HbYIK
4yHUHPmrViB4htwbiJlgVZlQ8n3z6kkSrpGC0XVdCJ4P55NEBhkBfzDa285BqC5HMeKNRVd6jzYk
+ia8I1eW89qtyFXI1rR1k+MnF3HbSfqRNmmNyFobx9/MIJXf5+j+TUjonbCnKrTa1WAIIDFNMD5A
cfnvU+qOlnt74pdf25SWQx6hk1vhMr44KTA5kHIKKY8KS9HeYqCY/KIRgRsqxIN7ZBNMuRmh2Bgr
x+ZyU5mSE8r84YQg4DAf4D9uSAut4dDGYAkvQ9zH4myWNcFy8gSZ5SebMFyZ5dXhVBtrJsNRHe7L
8+EaPAIhLwFumvUA34PfMU5VAkd+UAYI2kGO5Nztz3plwPmL4vkFIV5ljucD2tasUJz3NQQghbZk
pKfNu6k1rFNkej1mmnmzMsMr64i5G2NKrhCS1cUdqZddmJJawQV10voY6gVK9tg8uIrnxccgULzT
pCjayqm5DEpU8gnlPGx4u/GoOp8lZdmc5hFHFX8PUE3VgOFgTLIj1aL4YQVl+SNqarwEYBitnJ/L
AD+PbJEU8Aq3gF2dj2ygMjRWpcldiZbpjtazPFW6rT2g+ZOvNAqvLCV1W1WnFkcBlyB4PpTiaVER
GAYQhwL9xmoYpx08a0DOU/Eu93D1vr1zrs6MFaSaBKrOMBcXSpzKQJlCICdwnrN9TvIIvN9T9sjo
JCsf8dryqZR1HMuh2STkYpNG2gC3I521ZCYogF2l+DsDDR7UvvUP9Hy1A+JGs2XCoKx0L+agcn6l
kFoxpO2QQfJFF5s17kdcitKqgfpBVUnBsWgfUu5YORKXC8erg6Ix+5JQc3EGOxV9EpjgzbauI+R1
IAO4CNIUe1Q7UR/CJWblc6rzTlhOS85PMvpNGonx4jhUokAwudEbkM7mLAaqRIcxDYydL80Oxjg0
moMoakgClkiPZZkiWxo6za7pfB2Jj758FAisvdzeTpdrbKHlBxBHo9/MDbLYTiCuffh3rPHQmxnq
i5XM3yZKLL+gGWR9bBq4mMdo0FHMBr8NuPL26FeWwOF1ScLHP/A1FmHekdYAMxfsglJPX3ykkGm3
YDg9QmUiBO5vDzbvmvPPTxRSac5ybkydvOD8oM4GuYgj4lQhgHQfMedCcEdO/dFLsc+lnCZPuZ8i
LNk2TbQzASC8vgosOUSMz6+wEGdfnKeEwqhA7Knd2nH0g7dQ/Yhbu4eobGy8vT3VywPESCRkkEi5
u5nv+VTbmXgQm+BttCGDc1wGzSGkybmyoa+MQgbG23JODehELFYPbyEI7eiPbzUbru6IEdAd0oLd
7vZc5r+yWLa58DjPBloL2+V8Ljn6tahKD0i1ztJeY6B3J0uNPun9NB3+YiSLDE/nUUetbJHJdgiY
wVrpu23vWyMyNZGDZI13knbXrYx0ZStSMOf5oSJYTTt9uT6BjUONNcvIwN2tN0Xbmntj0PpHVaNI
v0n1On6fjtD1atmVH+veen35GCE6EEMaqASL9ubi2KPVS1EnBUU1gxUf6IFPu7xHojIWg/EX6/cb
qeD8Xr1lFxA5mK6VrdajzFPCjorhkEF+j54RPlxrR8yfbblVJDOa0SsCbenFhrQ9/KrUEZJlqU/6
O6Tvio+FYmkfNQVY76ZrbMdN8yx/9W2FPS/ANZ6SKgWz5WKi3DMMiW902wH05D0eS4Wr9o65ctiu
HQO87ij+zSACurfnx6Af8YgWBmrtEA2RCJ10ZFv1qdpi6/f68hRT4SVJ+KCbShnwfChVg6gMthqs
k8S9RKLXusMUz9z4OvIsrz9ycxVlRg7Q9jYXR06ravyBOr3bll49HiYHkezAdOQ+6YZvt0e6Fqzo
vnHLzJgqOtLnk7IaPXWmBOONsiraU1PV1jazAfjfHuXaKnGf6iaUWgQyzUWwKnSPol8E5bK0cRBB
oB9V6Mosj1OTdyt358VQTIKkmocwfl/AShZJ0oTkUm212LwKs5MHnFLGY9m3VBcgH+1uz+riXM1D
8eUsyqMkusbi4lLw9IZOhPJRnKX+EdSzjxpREzxjz1Z/djoDJmqEeUe+MsMrw1okuTgN0TrglllG
SfrX7IMCW0xuAJLq5hMOiuohSWPtJ+qrdo4elFmunLOLfcJ74c9BF5vfRBon9YMBsZLQ0Mg9x2Y/
hn13vP1FrywenTuHyelAZsQF9Cjk8YM7Iz1Z5DfvwCqjzylxdQPybawcsYsMb54QUEnas3xGABLn
G98DTBLqQzzbcyYDBm0IvBo6WjzAFZRD0WnWFzKw+N0g65UTd3HJLQZe7Br0XADSG8G0baDt7HkB
ImQUmpAz1Skq7tBcD1z0vODcY0H8QCM5XTmLV7cP9wBnno4J5ejziSO1NzWVg+GJCLCi2oQCcUvX
D5LswUMUIIKUUaIKMqJscbq9uNcH1k0kqOiakWueD1xJFSFW/Lbo6sXdBxQ/yq8aZkQHyC/SLYWc
DjFWkK8/o3NPnBIgNx/Ar8XX7gvFUTMvn2cLZH9LsapOH9omy/rvU5cpz11QRwpl27z6fnu2Vw4M
zyeevnxnRwdOdz5bK5+MckT9ZovggjLBH2nBw+NbLN+/fhzSTZ1E0wE8uuy1cVNopV3BmLYoQM2+
OmPl3QcBTJWV5bs2IaIqNQuOHDaMiwmFzSSNxIvFrIyMhWuOC8NUd2v92CsRQP45yuJYBjFK7Uh9
iC0CIM1BWh5a7oEzKxDJVxdDAHqRptMYgY5JV2ZxUyAkVaZdoAGysXLtc6CM6lutlbS4wA+5txfp
ytaX5LN411tzr3mJm8Mux3ayxBNbxN/Q3EO5Em3wfjxVnbCPPv66mw6J9pUFuxLhSFXQupkzI0Ah
iyRCyEAqWG2pqM2l1XdqLl/RRZyeemLCPdSWzDWn2WHOkUjL357utUW05toWdQSK/MutguWd36Qx
u6RNrfEAER07xghen4bEzuvvJUnCDsyNmoh1AY51aPBUPrQe6El1fshFXrqScsJKzLw2IcqEQPYk
fEV72S4M+spuxwovN1Skyr0zyfLUlLlxxCBYf20hi105l0FmHKfkSbwIz86AZxw+X9q2mgsPedCO
e6y/xgMkxrXi59VZSWKHIEk3eUOehyi6M4U/KswqUNrilAe9f0QBHRGfpJz+5gNy8VFMpB5If+J8
qDgEmJ/KRNvWmGKe4CsYpwL7lDuLbZKt7L5rh42VIiBq5Ga0ss7HwjYhahqLL6jr1c8YXuIxbKDH
xdjjug1uEZuxm/LD7R0/XyNnTyxWjUfO7zo5RZQlMqAA1+5nA9F+dBqxndQyjtyx7NMMsjwmjChQ
Zw+3R7xshfweEuiPqRJTIMaeT9PMLdwARod4HDltuEnC33rXg6PuY7ST0aqj+EB4s/dhYCJAB7FQ
3Xu5gFd2+4dcCzPMm0c76C66MoswGksVk6ggBOYW2dqz0ngQHaFS9gfqZ/33LG9MuEpo0nd1pa+h
3i7H5tgTV3Hxo35P8ej8GxSKbw3d6OHVlUel2xrGQH8PAqqzh4xUu6UR9LsmrZXd7SlfXoUMa6rs
Y2OGXi2ftjDzKWTN9znG6sZOjpH3GCN3d7w9yuXxnAcA1M3bmQtCLCcX29OIi9wAZNYzT7ru46SF
rst+KMqPrx5JGkSA+RVNarbMITBFpyo3SA06oq7tnHgKDr3tlAd16q2VSV0eTprmMz7XtgBeXGDJ
fCs0lawOQeA7aKrrWY50uFDQn8psbw/uVdlI9L9XIsLl6aTHDPaTFy7PT/oe59uklbC2WxOsHgTN
8GiUGNtWeMwdhwaKbR0CF37t95wLSDzgeRnSXFp+z6yL4xrzKfSwgqmF1DtURIac98ZDCpZmZTPO
5+s89JwPNm+jP3qC0iopfxu/8U+p7tIGyfYdbdkNdXzdFZPZY9YLS1/mer2jgt69Pg5pQLyQTgBn
Pic5i3CbC7MxfTqe6ElE8hEjw26rBManTDHxKypQP0WfFAPZASXTssLz2Ey1td9wub4WNybkqZlJ
QhSYN90fnyAPHTtohDq6Y6U4d0o/+ocxkd4xTssJPaFxLZ27PJmMR/cZygoDUng5Hy9BuhHBH2fE
S0dzHqkzD9ihBbrrG+1ajeEywklBpNFUzeJJDOnifCi0Y4YJZYzeNYuqw12gq5uX0EG1XW2buIUo
PJhfsF6p7n382Fd21uVnZWwWFRSzQUFlSadKRhUd1SHvXRuz8Mcetswxow6LypVWHwKhtitZ8uVn
nXNG2r/kPzZ4Rf18rnjmDIoVyt6t9JII7kTDBvEMrE5F9en2Af3d6Dw/NJL+luZoc0Nt7nSdD5UE
FZR0xx9dzGNRZuxTAESbysAsFVif3n7oUMh6ttDVeQMCd0TtP6IlspklonEpwGJ30yeptdIxvbxV
4ItS6yNhnu+zJeIPqahWABlGM8UT2A4i3hNs9T4bf92e+2W8INmDTkO2wvP/IhjCDsd3SzU60P0e
GN4UjK0LzKcMDyrOo4DRdGANsKJsF5nORt+kIyp5t3/ClYWm4DKPTo0O6Yd50/9xXg3HQzM2ttnU
pogfyBOao6hMcQc4Xl95BF0dii4adBsCPyjf86HqSCcVqdUe/q3S4IaWBaqxDeoa4Wep9+3KRXMl
KaNGzGNLB/o2v/UWMws6NqFAoATdo17Jtq2mwpJGQedOh5667RoVtro+hgdowfZTPVX+sz+pa9zO
aysMT5a+kA1kG/bPcs4oBmpqPuAwpKoPo6bjFBNijp2lE+qE+MGia6kpbpLA6ieVad/fXt2rw3Ou
CB4m+3n52DWS2gtiAoerqrGJ4qRKGznuZh50ZA6oI4KFB1DdoulQYBSryFdjq23WgHbyTACaX4aL
NWgsAB3tUA2u36XFtwLPwoPuteamb8t25cheiZBcPOxl+J9URJYEFl9t7Uab+gFRlBjhDDyUj/0A
oBthmxCNG6053P6013YzcCP6tfQvVTKo85WNsMWMDcn2KjtneG8xgAubsbmPinANv3EtGs2FkTln
AuG13MlNK7CODAE3xnqh5acgsxFXwgotj1aCwRxqF6GY+gT3NvxW2LRLeqtMxq7wc264vNTte+xR
zZ2XIzqUt830rjERuwbz7Oxe/SG5uOdazIyn0H5jEv6IQKiayt6Pkc+z/KLHRgy3ILfQZ5ugqkbq
ayUs/MbBLedIZx2QEYyRmWtwvm4jSOM0EyOmzcCNexWx88zB8m/KhNxPZadOu94Lmxy95XT8hhSD
icQ84qpo/Jaz+ExPdbTfNCJC/DPG1+IJQHYzHmiFqv6+b1GUn1DY+NIKicUsQm2sEcYx1vRWUX3F
25iV39k7BNuH5i7SwvyRifsJiszaq/mh7BWdfIf0yIHVoC1KTlmQV4k0WyT40MB8J/L+zu8RV8RF
S94lBmYKr15FqG88OUHFgqBcHr+45VAGcGzdKtWm7yaifHc5YgSfEfxewzVfOXmw5W3YoUAIoIrM
//8fG4YSU1KCUTBcrc2KtwjCpPeNMLMjvU3/6+1ZXTkQc/+KsoxFcnKRzbZ1AHesZSj638M9ybXt
qs0U3EUJfTk4ltqDhv3RSrf2SiQjuaS9yZekc2YsVk6ftEp6CJC5KVLNb0MZUuDKSMKqHih806wh
C6/N8c/hFgciS+Z3NeV6d8Lxyjk2to+8mpiwS9w4NVdVR2MULxqjEK8/+NzMlLaojP4mV5yvIw4Q
GBCOOuSzICuzjVCHEb0q6r4bvfb8/e2VnG+axbGnv8IbwQBOBZpnMctaRe3EpzcH3ncSuzosMfRu
9V8Y7WDkNSjaNscE5ldZ0564PfCVz8vAEsgmy6lCwTmfpQlDxO68WnXjRqK/02vKe9BSv/JWdE9D
A57SGtVs5cte2UEO9R/qvTTciXKLyfZ2gVSyZMzOq2yuCuRIHlPAf9Gm1nBqykZbrnzeK2cSUriY
kSK0CinPns+yRgbMaScES3s0kD6roqmfRiNyvmU08lZeudc+KL2CeTUJ41S7zodSEshgKQIPyIw2
AjVQVSpa8bYIu4AuSKNpW62y7ee+gBt0eyWvzREio66jvUQuZc5f/Y+4E5ZUgHTSSLz3kHveAcof
P5aJgl574qTVSjpzdTBwZ7DE5rkuyRuV1Jo4pKuOmN80fKD9XNfwxG1jb9nhuJIlXjsb5nwhAsoH
JbKE2sRY+DV4waiudLyqxgtO7e6xfoaWRvKjUpWZYwEtL22HBkC7Apa/NjhIH7INisSMvkgRgzhV
HLAwmospqSXuRpn4R+mhLb8tRx98WJNoxr+pp1vvQZNav24v6bXBqVXOwHlakvyG8yU1da7Ivi51
itEVaunWpDrtwcgT82sSV+Jk4jm+CwD7ufXo12tsrivJOdkSwDEuZ8BpS8yCrg3tkFu9jj5YkCU7
ECjoTNEH6D/EDuhZI/fiewwCLJe3areD8568/kHGD6ANQP6F6MeyFhfTbkd4TeiAOPXM7RCC34SF
YxwVdDj+Ij5ABZ4B8yQHF9l5oMZRIJEmd9M+QLoxsNtDSoPjlBbYm9xe0/kYLiM9QwB04vVOWqmf
r6nmYzWRykh3savX/W1P7eRn1oNC3mDo0t93uDW/fkg0FTg6VBmBIiNCcz6kb+YF8mDVREjqu+cW
cuQO204ca/ivw9fCQ6rs9hwvY6CNihUyErMg0qzlcz4gWuJIkXb15CaqFn0CqIE/n6eom1hg6ZRi
l7hBcXlYCby/r43zL2tTWqSPM6s6UBdZnJZBE1hAx92I2KcvcnfoBvW+N0zvaw99/F3ijcFD49eI
X49FZh2bNOofYwyPD2PniB+3P8BleCQFpKVKMx9y20VDtUPQFDUIhbIfuv/vBXzhbxkYwceCTOLj
7aEuYwQp4Axg4jblSbTMHOgI1CnShxM2LrX5PrRDD2vfWTjDqORxEsNnJ6+cY4CD7e72wJcbec49
iQ00VUmRlhhzHzK0RRUM4YumCjOEGWL08CYEblX05UX9TmvjZoUyeGVfqToXOCkdgEEys/N9ZUOE
7nAqHF115mB0iVXt9FZxdhiyTN+wPCoPsSbf3p7mte9Lokuqy96CGD3/pj+uVSzK1KEt0SOs6jB8
UUrtKe1V619ioHJU+wBhUd78rk0OvBIoru0hwh7AYCDXPD0Xk/VT3DqdIBZ4riJx1Ayaf68kAPnj
JvZXbvNLYL1tk66ApsDehz20rKfWTVslvYmLhQ4EFPhsHyEjH9upa1de/lSnQ79J8JZ1I60fTlL1
x39Dkq33aKpigtok8aNWSv94+8Nf2180LCnSg7zi2l8cZ7zFIhwLCCLhBLNgE6AziQdFRhINYcrM
TpljhvHK8/vaYpM6UZ+BFwdSelEPi3Jsu6Khh3tXFP2DM6naBxxak5Nd6+mPDMPGewA80lVjo1+J
XldnyxUEjpMXMUXt822m5qhfeSW6yFT4m6ehVvMtbVjlI6pXzV0V+N5K2Li2uzi/HCcT0C0Nr/Px
UhC5vQyxpIQh2u6HgXuOVA8jiMHOV26DeaEWcZkAxdek0U6QWtZw8xTz3dkVEwncoXlLS8JgGZv+
5fZ2ubJ0VGjmNxSVKPLfxXEpkfgb7ToaUY9Nh3KLUaE8lRlyOIZZREeh4ibj1mGDoyhsDmVl31wJ
TKRnEHx5wPGUWgJ+KeCWXU19yp38qcAnqyxPZtFrTy0mZPcUyNvNoA756wMwOQQX+gxN4r5bLKFJ
8muGYTYrpdb4uBoGlhp4Qe9FZ77Ycagdbn/g3zCB5ToCyyVpQdTA5Ko93zI6SrVajKujS3803iLu
HO/wqBz3U29abwu9zb+oKDu7I54ou0Fgh7irKmFBMPXi92FboEuPXqSxdUoeQSs/7cpupstOoKVu
jwP7sgRJ/kbnsm5G18ql9hw7ynSSXVu+A+iWffPxf9uJEdnUuK+CTwWvxO8Rlj4CSUgj32N1Ge4m
/AEeGsLQUcTRGoX5Sq2fcgmdqvnVa1DvX4QyON/FJPVucHszrxHOKfo+cUNEdD7XQlfkXip4o95Z
aGB87wH5+9vcz8QD2suIDax8qStxhhOoClp1tGHBDZ0vYhpRDg5yKv5mhz3lJiXp3LcoON/PDXZe
jWGm340Yqx0tfJERNHey7+04FuEuN9TQLaWSPYKCNQ6hLNKHuOqx22tjxVzZ2pdvD9J+SKs0JegM
kJOf/8qwK2WUjWJwIy8fKMpPRnivjXl6zzXpfEG6HRndHDV3PmU2FhvRjN6H2x/qyomeWQK0B4DV
o7Kw+AUmUnx4QwoOV0j8uPOxyL7Dt6B7sRKbdk3XIKz9v+ydyXLbWLauX6Ui5/BB30TcqgEIkFRD
dZYsyxOELMvo243+6e8Hp7PKpFhi+QxunBtxInKQFiVBAPZeezV/4+PLZ//+OQCziksu9ETwKgfn
QNLWcK+7AFc+kFb4jDZYQ79GjSZBlVZBPWDubuXqiUrryM0yEVd0aFVg1rTDItcIFMyv4kH2cBRq
qi+hNEXbhDlnvbHxAojdMI5y+VzJ1fbE3R7Zt1yYjINKAYLS4cYAcqhje1QoJHTG2Ho09zs8ZAIM
Il0M6rXyVJxYQuJBCANTtgjTMpAn2Tk432F4qrCiU6TpSxM5OyUYUnwEu+rC6aevGqijdSJ3NyqW
n2d6gCA3097u4/sL6+0t04mAQ8cRD84Enbv9pa1ryTxEtGU9sGXqo9XijON2BspMokCu+/1rHRle
g2SRSV4XyAWT3IPdHjnUN/LMPpnVQZQXM9YZVwbEU6Z5QW0LV+8a0ezyeZrstaM3k44ZPGzGlUbL
yAZ4M8rRWoHqciKPf5sRAAKxfvC3SHDRvtx/BkOszU4A9wJTdoKLK2ol2swY45zYw29j3f5lls9/
Sd3boYJKYmudB7bNDplf292FqPAvwLlDPDtJr6/ff97HLsi2pV8EXoBB2MHyahOzM8Y87XGcgyBp
l/gCYV0KZwqzQzcAZnMiRT72HEHJL2+WXgKKdfs3iKmmAhBB9J7WN+GunEVxrxrjqYP/bTCmS4Es
hoY8E7micvAYAcw5Q5F3PYYBtVhDvUxN18Fo5oYJVXMzG05wU6eStiurMPfMXtZv3n+qR3YM10aV
gzR1oQQcPFW6GpE+JFwfQZzCw2ELj/FWiN00T7X//qXeJpE0vDSgHoQj8qdDxgOC1Z06w5nxMG8C
3ppWifSY5Kp1HioKCAjG8Ph9FGrwSn2Qnmq4vRXmW9ptdIW4WeZUb4YAtYSrQKi23GiMhcUK34/g
whpEelHIrVmjcIQq7Q/jxM8RBsmrQK+6T23dveRRq92LeM78tIpGRAR765LZUHv3/sM5tg6g3oKX
XdikcMv3V1sZjTrGQXnPCLur6GOjJnQnmWW0maRK07CNti007foBraJEkz8i4W6cSEGPrXeyAZRQ
iWcUSwd/QWAXetA4/AWDgdmqGwU5aN3EFid6vse2MZRO4P7QS2HPH4SnFAO9XkXexpMkuX+oSznF
TxK/1WnjzHO97hkXn73/aI/eGD0z8wcv4+20PhY6vgEFG5nj+VEe1eBKMylV3r/KsY2EHAhiSwQN
WD0H4QLydlGWEfGwyFrZb6XA8uK8xwKslH4ft0PXAng6LRP05Kjf99dKQMIA0s5CHqO3k005DI5n
RnLkB6FT/XYOsTRIeE9Ln5qLHiyKrlTKLNaczgNOippr17U+Yzp8zaPoVEvm2MKwiOuLkKJKB+rw
AbZtY1cG8V1nd13HZqZvWxVPdFXGhBvS4olj8tj7guKMZB2EXCZJB+uQaUZRdZgOeQG8IeS882bT
jHXoIQwdrN9fGkcCnyqTaQOtoEohE9x/X+CetIR+Wu+1lo2qbDA7q7CQEjAjvdiqoUOlIOmgNIc0
OLGnj/SekCEi4gFBWvpPh5rUkQqsidlP5+HpIg0bTDctV4mB4m3rylGeEJHG61rGI21aRQM9VKpQ
vVis1DGdYh13uJFxdm3DCtah9/5TOfICFsQqzU1auYs+yf5TKSe7EmRCg6fjY7CZ6+ypwv4HNXDz
RGg9sv/3LnTwppkn52KIwE/OIAVGD7UQrEm01hAnGn1vE31KUJiMJAwgnxhD7N9Qh9X20EksYHWe
5Y3T9w2VryL5jS41ri0X8pXUYMzz/lM8dq7BnDQZB1BPQbA7WFwqs4BOExiRdokZlatZmjD61VAE
XdlDoX6VqlxGr0JuNVQLq3jA0kXTbwutqu6qekJvmpjRpeRPQXiRUHZu2Czj4/t/47EHQ6t8GbUR
S/RDoZ0Uu0FTr1BISRTJvM8wXfW1uJP8MHVorSSj5eGYbf5+PIaJBF5/wZtTYh40cNDMx1/VCnrP
ZjFvk6j80gcxbYgxFKv3b+/Y9qaNCtBmGRTQhdh/70EiZmg1EpmFExZPZtl/ThG93MRVW1xKbR+c
xYoFH6LWTzETjgxlyITZgGAcF3OTQ/JsZQ9Bq5jLWQp3QHi5aMqreLJCx53KydhAt23wm+eux1ip
hm2TAQkaRAGglTH5KRrTkfi9lF6LKtZCzjrs5eNcmYV9pvCWc5Gd9Ymg7RHJj63VTOfmWIsToW05
efarTe59kYpFmIXXe4jIxoVJ7xPIS56qRP0dHj7wk9u8MnxjqLFbx5M0vggRf7vCGbm8lux2+G/E
L5t2D5NrhkOkJfuvXWXbYaDktJ5kKVeI0mifpnCoGP4N44lbPRYpkfbl4FiOERg++1dK8ypiNs2V
yEJHP8sxMZbMplynhtWdKAeOrWW4svR5QbrzPwepRVLMU5rjjurFljrEvrANjOXofmLKJcSWmqR9
RcQZU1KQ2Orvh4mFprjgdsEhvrVdUcMyzUOu3RWSue6kdrEUww94Z/PVeqUXSXs+mrXtv799jywk
0DmMNokWS9/g4D1GRp2xqxsIrmFsFttUlgc30SU6B3EgjXcj+OR606uS9nECro5igtBPFSdHnjpw
D7q+5jKAQ5V7/wWbuPPZsxQIj2Warp0p+2hVPX7Vs9qt5cqpztDSjzzBaf37Kwv0w4JiJawj/nMQ
JIPYapyhzVjDSWx/wWxW32STWjGQKroTp7B69CZhwXLmIxAMvWn/Jgt5toNZxkZnGC3ja4Mj8TlT
KHXT9Fl/Nrdd5EWhGa0sJS4+dXgcmvAdAGPMso6lUWoHfQgnqRnO+nHUvCIUGX5pU4FYM+By8bmu
tAgLpMK8HoI51tBPn/svOWTtgec5D+ddFmPHqkldDcscbaV2cGYMe+NTVhlH7xLm6NLtg6R6CL20
7QiPWjG0XmNI5b00DucZcmsTNFK1cZmgTxJGlOO8o8lan6hzjgRg4ElUOQQl0MmHC1nFrjBqLNF6
Le5TTwTOj7VWhgJ8KxgEI1If3t83R9Iq+l4LfWMJ92/ERLo6sSMSx9YzRUXBDC+xw2OwOKWMciT4
kSBSFPwwL6KI2182Vi2Cvoik1pPrDr+MIs1jnOEqMZ1XNnad79/TsVgAanY5xJDuZCK9fzFsXBMj
62eKOEmfHhpbb4rbuQ1gjHeD0HYDracJB6O2x6ySQtofUrz33v8TjswzQFegk8CoEr1wWpn7fwOI
KKPvNQUepWLUIzr9Ghp+rlOJ4NKcC1AtTag1n1St1POdFU3q4vHdh6swzAr7xOOwuNTBGUsuy9iH
BB0M42FcioST1ZmGGzEQyuEyT7Ch7lujXedhMflxI9TIRR7nlBDZkatCF2ZGgXzxouh/8MYjNXXw
kJRqr6+E+QgTusZDsA70j3Kl6pPLcMS5SKOufHn/wR+7rI7eLgQvBuKs7P3n3gB60zsdies+sWWx
SuEBXaYlg5qVg5+Jj0w0aAwOqBO79uhlkfcD0EwDkJNo/7KaHCuRGcz4jheG82jU6kjBoAcJgP8m
rNZyW3RrcwzHE5f90Vg8eLcAS8iclpkqtosH1YpcKE1qqxJ4+5QttdMUgbd8rznZ14mG+V3iNFrq
ZrC4t92kF6arpGmdecGQ1CoY9gjDWDtImNYj4I3KIoSEBhNPDMbcuZTC1/dfzZEY8KNGXIbcvJrD
BEgx0mionAHlqqZQcRLWMyeebkwNvY0cG8auORUHjl2Q6M04ccGI0DrafynA0yra5khlyRY+CyuS
5+yiyar4PG+ROThRPxxZAWwuWhHLEmDJH6yAbrSFHXHKe0GQGI+iMR/Kas53Ns7A3lj31Tquw1MH
/5GzwgI8tSgOLBy0Q9TaxEBSTyur9qZSwuQlyYSFL7icoSdr1sNj7Qz/jUY3jGNY4kt5sJT8B480
lPW5bfOGVlU0pDAjkrndRvbIsDaNHQTQZkWKdlaoD/n5MNe6lLhFo6rPv72SIHGjdc08e0mlD551
zHwhyJu69pTcbm8nq9FcKbSIYxG2dOv3r3XsGdNRZ9iNqgmZ3cEicjIKf7Zz7UVJ09+FSjY9pHIP
aDm37U0xV9GJXt2RdQQpErcHdJQ4/Q9b+ZZOSwOsCXVgptS36Pfh/DnKSTQiV9km13UVkNihFniK
VnMkEVh0aKAQkj8jLHZwaGqZkhiqYA4Wg7LxIyQfPMWmHH7/aR7ZkkhF0qBmeqAhT3oQnmPZiS0n
rYSXpV0Jg1yfzhNhJavISevff5DMthgTkEot1zy4obmc2rzXutZzCqOu3TAFu5WWoX3HE3iFLWSt
A70L/ffv78hqcTBohIDFMBEZs8P7S8q+zOEjepoZF7t+wrV2xpoE66lJXQ/BSQTckdWCBMgigvXn
+X5wPTtNkeevuZ7ZtdF3fFkBALdoZFSyNl3ViZzeFqV6ivB77CaZLFDfLfkEXfL9INBlRdMgZt16
9ahbrc8Rm8xbnrZzIcdD+KnNVSjN7z/Xt6QvBg0QzCAXw4hiHHpwo5Af46yfehoFaoauwWCh5rAe
6HnniRv3SokMvJC1ByW25vRM6engrsOpbjeQN+OvkfihDa2Xhvq1MUar2YSykbzagdFM6xx1ShKD
oUny25mNuQhDaMFNKIrwW9RWLe5uSL9f9v1sP2alneerSWijtWZCnYUn0sY3r5MtwVEOdAg0OZ3m
5fNfxrGUbmNnxA13CdDlNuGs8katkd2s0udtYvQvPIaH95/s20vCuactsYi3QTY5VD6JZtCOaVEa
Xp0Iu7+YxSAS1+gpVV16BM28llLynfMO7M6pFPFNyGFQypiF0pWjhJnZQRgX6P8M0xQayPijJeGH
i3V9HPD+T2zK5ffsJUnLdYio1APM1PG12H+qwganoNa4yqBgMkzuhEb4ChPp8gyR95O2Nm82BxeD
0wIGcSHsOocqKghyFFaH8jpA0EK7TRGuuGwa7aaTosAv844D8f33d+R6S865eKbi20Fzdv/mVCtv
MKnkIdJRyqXOrc3A+R5FcY+tdsYa/uhoBdoG71/0yKJhOkbCSRYAlO+wpGjqSnamsDG8eZyrx3CC
mF0xeGDyWqNKhG/ARaUYp+qYI6+RPIfpL50H+vKH6VyJWXAn4sT0RFRLD30IKm2boIyxUsPqpK/k
j3ztYNEsrxHkBvkVa/PguQq1y2RM3jUP8HFWuaKN9Msa1/HBJfVIbmW7DgEsqKFKaV6raFcbUSJd
K6Vh32EOk39X6xxlA66IjggEmFl3TVn040aNVVVZObiA7eQ0UlChCKLxvEtgRLlqK4ONtIK2TFxZ
QmMPgUi136ZTiAn4+2/wbYHKeEM2QfjQNFuAZAcFqh4ZpG34nXlVGMuXsAHUwS2mpH9B/7WoFuez
6qIzGrQvrcloElcaY6vFYUSz8u37f8oPpej9R70AXWhd0cOiUj2cmstCjxqakqWHenk7+mqgRdM6
1sJZ8pFWVJlrzDMlCUhq03JbLAakczBX3cOcyKZYNZiuN64Mvr1wTdS1SxalrMvrGHJBuopFktwU
tZzFbqOZ0xPtbaPCpHOUUr/EreR+Ui3UrbJUx+YCf+X2LJ4HJ8YvwFCg7MC9P1Ggvg16aHGghQ4l
FZUVes77+zWp7aIczYIqyCG6z6WWr5ssqW7ff6ZvowKUIkY1lD8M6N8wUOsGokeIvoin2k33FPW6
CRnLVPDVQaXPlSkAT62n5QA+fIlMsKgLlqQAeZX9+8JNLswXhKuntsngc5azeLMm9e2yhZ/ZF40n
1bYMZm02/BlYxraYgmAVWWX8J6Lrv/Zc1cUPl/WXspqaGM32g3/+47p6LT62zetru3uu/s/yo//8
1n/s/5Of/Pmbvef2ee8fftHG7XTbvTbT3Ssm0O1fzu7Ld/6nH/7t9cdvuZ+q17//8VJ2Rbv8tjAu
iz9+fnT27e9/0Jv55f0uv//nh1fPOT/38bn42+4Zikj55oden0X79z8U9QNzK5zNFoFjMKtLn2B4
/fkJ+SiIGQRgCZs0Y/74W1E2bfT3P3Ttww8vEhT4eF2gggkBAiGAPz9iVEF3F6DwMsSHWfDXzd/8
+dL/fOLHbe5/qA78a21QogJfBIsCeJFNTm1xkNa0iVGoJjwj17Km2S3MMd449oQgTSFs/J6Es1Ej
zQ+UpL+WemOj1PGZjtHQWlbT+yxR/a7A9CcuejKzqL5sSuOTlseGq+VT50u2yPzIYebf9FpzZuJy
7GZ6kHlMU8t1lCb2CuXG14zTwlV7Dfsek6A7ytZ3q4pJHZ18i5zkoxXSJ+hHe3TNTvnYm/JWssLK
rSUavn3O9xjiqQq7s6L+0pXh4CqtmXuSHtzn/U9Hk99awPdlzn/7S3V/yf9jF780pSi/t+9+1+a1
XNaQOPymvT3xP2QTLGfsf/21zt5sgk/PbfzCRlixKfe2wfJj/9wGACQoYEmjyZ+ZHP+6DRhZgzkk
QLERWIF/7QLlw6J2teBrqbap8n/ZBctHbAK+HwUl1Bbt39oFS8dzbxcA+kf/iTybEElvdInZvyT3
bSWp4TBqChptkdt0t7F+G7TPAY0bq/VEsZ3kjTV+lE03cbbXlCV3TnytaqEfRKpn0MaT8mqthSYK
HrVrN/dF/UmrPhnTQzQ8yExB6puurb1kGZ+4ybgxg9Vk35rli21dheOlFdwZyscfz///2UL9H7gG
l9D075fgpnvOf116y3f/XHm6/mFB24FBgl2JEznH+s8AzCfI2y/WttTKS5r5c+Ep2gd6k0RDlipT
Csqaf4ZfPoImQ7hexFhh7Ojqby089sMvCw94FMXV4rDFHwdwg9+8v/BC2jCyOoT59WBU7b2dd90W
I+rkq9I3jY3ifl88xqYVOVvylexsmIfat8qRleckidG6Qzs121jdxVNUjn4Nt+6O1Fa60+Qpvk5y
R32cRim+VwwRfAnLQfNLkuSqq9MrpUSmZY2Y58qYUv0hpLq9aKVeupNUiMTxGIwPStBioWqPGi6K
APlfAnkEP9tDghppVbtqo/eWr+p9Ga0GY7bPc7UaxbpscQ+Ph6G+XBSbfhYav7Wu/7Po+v9dnrGI
wP/79b0ri/a1eA2b/Txj+aE/l7kqf1iqBdrcYFth/y1r9ucytz/QDgJgDZDehBGyiMD9FWG1D4vF
HNy4RV6C5gbr7688Q/kAng1wIhkL9P1FNvqv+P8f5Bl8/95KJ9Gwid+gqCBJLT2FwzGjZEiq0WlZ
usq0Xo5dxhlyu+r6VhduFGGm6Y5tNX7RyftIKnpM5dxwwfS5I3BP9HqhYpt+NY3CR+xKlf0itM1L
IVox+0mMebw3I0h2r6tzqri52VjfUg39upXIcye7NFTAKUNm5LlXqxlIB6Dfr5Y+quNGl7CbwH3e
8GwraOpVF0To5NXh0F/rhZ6QjkxBXri6kkwP2WjIbhDXc+B2dY14qN3p9hp3OIFdAHD9hzyX+tot
4m7EEnieEyR4x+bLBLRlp2uhHbmlsMSDptdODAONxsrKCvRAcfWqlGjY53MGVFDJO1dSjKpyq1CS
twmw6tuSNPDVrLNSWil6U57rtRQnyE+Wce7Ndmw/tWOLcYyjtWXrMjWyKq8YJD13B8OoLjmT03Nb
rqruKpta1d5YdRltNeSycWWbGbFv9UkN77NZC89juZsRpMkyK11ZqZZfpeZsNquIx/2EHRjjE6Gp
rTt1U3lhzYjSEk4gZK1aJ6lqv3JKXxnUalrVgOHaVSWjOc6zUfsbRJhrA0v4GkyyZGaqG4U0mNzQ
CEbLhU+RhG5n2dxEpU/p97Qz9N1ojOl12OvaV6PoNEQNcpuYZ5edY3plh7vGbgpz5VyNezXh9WJV
5eRK5lHFjrel3tudj9JifqamSoP9yxCZkgsIXdxQ5a1r8D4K7zlKL8EvxY+1UjmfTKp8w+8CWTu3
uo66NosdHE/rrJUmNzecOyuVsk8s8AzWS28Go48jYp/5UlA4aCciSOB4bZM2zVU6FpAL2ma+UCFQ
jp4Tl33n6Sw++0yyKuVTrmbIhveGEvrZMJihH9IJT/wwEGG1CqXwWWbslniSGJQH3ZT6Z/rzOhzQ
sR0SLFFR23HTXm/N1YT7puFWk0P7Kqqs5kmW54whYduNuzCVRAS8SGuwwi7T9i4N22A3JJPMNRwd
3jtqZ/miKhxnZwgiZSjWWYnpuFE3M/gDvJveCKewqpVtjRgVsYZKfWXPEaCQlvg/YpUE+tqNJMEV
DIlQAifPNK/sQrISX6n19lpP+lLyq3HoG5rScvwKZDbColSu+p0jifAc8RRlC6k1yegRtEXulenU
5OeI01dnArpYvTZyJSlWThFqxUqR+8Rw507bIYcse6FTj7fWYAvDdYZaYmHGOsrPeSTk2zyW5eKs
0qTxMteSgUVcyEa8UmsYAvdtboHNJIr2P3GR/3tE/YGIydL8//eH1JnIXv9Wfqcg3iuhf/7cn+eU
pH8AaEf/DmzhchhQFP91UPERcy7QhkuXgt7dj3bwz5PK0D/ogBHRAQE+i6rML7UAH3F4wXqhXw2s
YBGR+I2Tamny/KsUoAimHEdCE2FFMJ8wlA+bJeVQqnMbSi4yJ8G2DZ7HpspcRlm22+I3c2uFyYbu
XEQqVRknOjU/kBcHF6c7vcz4oGIvYMT9dDCZJ1gHuHG6oOclGDxTEa9tcjwAClr2yTYGB+fVsElW
5dAo4kwao8StRBWcCdpompt2KJOwi8zBDXXkjUKpsC+FraXRqsxTka8MveNMNNPsoh34Il3kz/3E
FDyKolq+4KGrqANaSkfoD25iJR9fhkGCbhvIJU0+IQdMAoz2scEqbXLtJG+3+RSr32KlR767FFof
reMeHJkuxUy67GyqVC9tpksaqc5tPuXxlxZRsNINJbg+rqDm+oTXwdqUwKFJchFnWKG2XbyK7Tz6
s5X5v9vyDwAUC0Pl32/Lq6WpxKZ8ef1WFvHzr2XSz5/9mUJqH4Cp/JgywxOhxPlnpURySW6I/g70
Lnz2fmj2/pVCqh8g+lKjUyaBImN3/iuFlEkhmSijaECfCmDC7+xLtsDezqRpSi8cBM+iq44UKTyW
/c0hT2atRu2YrSSr7O2tPEXKZTKpr3F1RS7xGb9pWphiWs2G/UUR1Wdsbc9MczCfsbadNkXUfDPo
g7rkBTcUiQaEONPACDLHwthoSOmcJy2U1DVUqY0dKLfKJFAGrm8IGZ8ro9Kvy4E5rlHUqds09VlK
Zxty9VoekanMvmva6OYVkrB+xiD9Y4vcxzVahnJ6JgD8fkwjI61glhlugjatVIbYD03pXVk3fiTY
I3a+Kc3kGuVKz8GT1EVvQV1PtjTvgFA6uzgvEOvUe84wZDHdtnjIyuZTnc+7Nk13CLmEm3ky3biQ
1sky0o6tye3KQvMnS6TeWJbmtQFAEfTHtJELlKGcfoUJ0hnCKQ9tqDkbgdlVHOsvWssDDJpGweA5
TK5FWb+iX2+x9+cVendI9LfVJay9y9wqv2GG8K22pW1lkDIzJXm0etnP7Vi5JzvW1h1m3O5Q6B81
RSrcrpPciYHYOhuHx6YG3xfO93VavWqR1F9KWXGfltbTnFvnRj6Gay1RvxVjvkIOLvLGSbot4uCi
LJzeHZtwcosqS5AYyZyrMNZ0FMaKZN3RtB+q16CREUD5XsrNGj8M8YoOCSQxJjnuLOrdzA9Dhozu
QdCYrqYLZLc7Q3XbpvaMUS2+MbRLXRPd1LtIze6j5i5T+UKQBaXbxvX4MR4hCmaOuGeW8NxmPR3N
ZD2WEpjmhj81R8Jy7SRxzjyGgZFhQ/BHH+FKNGp7bTFr8vqp7Tcw1xS6qmbFnxqaK7ULt1GTmX6U
pL5WttbKrqXarazcWcVypmzGgQx0pIPgUvrVvipLtgsfDmHHutPccYi+TDErWpMAn1SDdWNg1jui
hnoh2ZLtI+9DL8HUfUWdVRfscMsuyHXcEBPUGqr8Kx7XZ4Myi21aNdsgtq9oBl93JMauoiIxVRuB
G3bBdkgWAZLRWiXxMt3JieRdlbqyWn4trcL20Fyu3GYu7FWfNwG31QfmE35xT6j1Q8TXMTcLMiFG
F3NVCJCldQuJ4XHItBx+jI4yZXcxBdqGdc68iXGlbiX3GGhObJCs/poMsYm8/2x6oSHpT1JExmuV
OMPV0kcl0frWdaRuVF0HmJxXqbwCScpvjPI6i4KnEt3zwKnO7WKdzI9dqnpOFPlOkJ8pCcLgQrKi
KyOab0WmT9vAVoLrpNmSoJB3dvMZ57AvO03uNnn5KuFLh8qyNPmWqDBfcb6ElryS2bqKwaEdx09G
HxOlwpKBdmw0K1NOdZ8TH5VKtV4l+og+hTVVW1zvhhu82KwNMhEh7JI622i98jErTL9zZHeMom0x
mrIvN9Z3fdZ2jlqGV2kyPxtTYF1FleHAq7uy05DDmTH6ygwbTx/C9Zg450F/GYcqiiCJXPhJnit3
3Yw10ZhIlbtg0y5Fik4BkIt85YyOl4baGTWTTp3UvdRAvzssZNdVY2xMpy5XBYMEt8wVm/+rXiZm
Ap7didbN5Ne+ic+7KLqJ+DOYh2KerI7PThsVfpxnq1Dt5WtaA56uSBcBppItyvIOosAG5S9pStGy
aJUNZP0vSq0sqvTzGLma3cKfqxNXVc0O8Jy2KLYMj3YyXyZDnbvdDOdqmq3zMag/a2OE/6EUruZk
ugMAzmtNJRRAEsXlq/EFMJuNbSICNWXwkrNUurSz1hVGPXgU//MXOZXOW836MuX5xSiH8VWTF4lv
Gfng0+9+ArfiGe14GWZSv5r08cUJZTdFeiWkgLT1eSdFUe4ZGdJsjD+2YStu4m6IWc1EehT47uWg
d4caTzbzS1gpkP8ohHeWubFm6fMYWdoKt6ptjUZ5JItnu7Y3bd3fj0rqMod5lEpIGnI9Pk1dv0vi
2rOnzC0RjfTmSHJ2oTVQ1OuFdA6zwZtjrATGHssrmHKxbxRF8VL2ikQ6CYAZvavneA6jle3Mt5YQ
6M3kMTD6a0Po35QeeW1AUKqHBs0LMDfNNcNPQzglO01Oxy9x1zteU5pwOMVVHPUcfiJYgX1UocFN
NXwnq9ZdWbZvkzF8prq+6OV2u6jErJRSObMozjZo8AyfkwzhFhCsjl8AkHRNs77Wm84tx6/w1jov
CfMny6EdZFlPRVH1Gz3uzLU9+20r985KFZYnyfEVdKsbRRIXcWl+D+HZrWQTD+3C0c/jhGXt0GHx
UiQSVvA8Xqp4MhbxRXym5eghtFplU5vmyyTaZu0YE7hneaxvQ52TtVMmUgQFnd6ztK11Twsq6SFr
Y8GgC6bhkvN7iWHFfrMsOEePqk/0ddudCNLuxpClnul0Xl+ZQdrckZxLV1hKG2dlTzkaDnb0PVDb
7LI1p+KmzoIiuoikUGzwBbA+I9QWgbXtZv1SEWJe59EUPVagrs4cTApW9TxrXx0RBJcZxwmpRQpF
aBpZtFrkKs2Q8cCK7jG0w/K5qSX9vCbG+rViduciGmV/NNL0zu5BhiHO0+IaWmT5VqhJdpfOgXpt
S1J8nvX2Ao2ZVkbWGNsuZsznxHJTuVpUiu+OXToruaMSx/Q5fTb1BHl2VRjnep6La4Cn6sWsTc+S
E7TfUicNCTV5fe90ovOIF0TfsTlPzGnw6iIZbuVwjvxBzoOXboRQ4gqkGM/gS6LS1tYyBAQAjzt5
iKoLLW2Erxu1fE1jIzoP2dyE96Zpb4w8xhRdmOOqyLK10T0b9riCo80hVeRt5tPlus7VqLseE9tI
/aY269gzmqa5HYBXnCOmMbtjpzLVnKOhdxNTH66WNpYrpYFYOXOMPFyoQ/ZLYqdxyySg6RLERunD
dTE/Q3Qcr6O0fm4dp/dorA1fBwNtLnLIctOGk9GTj2kDLGSzMO/MpJrPVSuo7+KO1I7yy3hKaxX/
GoIjfoaxNG9C+nkXViRjTVteBVZ6EdhirQWeyVHmiOdeGeVN1+YvdDpX0mQCljcvrKmhM6JmZ0Xb
45iSjbT48Juwhy9Jnl1Ik8aBnQ1najMk16iuG56FhjCpWUVsMn48WBqGubwJ1EyldyVf5mbneJGh
bdqUrGFo6I+JxLPoL95aZdldVNnsI2x312Fkr9G/8m3BuoWet56jbtgMSfbNHBV11Y1W9jAF/ScR
zN1KS7GrQtw79zsqO60ownVZOhdlqBTrGt39a3B8uzK3UcXVH+o0pUzNnPrjOAx+2pu3TnSBPbXw
5wD1IsBdrihg+8Jjp9/kVOvcHm9qbOTlZqeUKfnoEHh1zEaOJWwIBfJDD4Ykr8JSWenqdNbFnVuh
SF8B4tsEUnw3hEJ3acKN63CQz/M4+ATtpvSsCuW+ZDLzc2vssC7sSud2DLvcN9Vgo6eybxvRJ81s
6kuL4aELiTBL3K6YPlNcfOasvkjMavS61tiq9vcamPi1hWDV2VgKlj7f+0x5vjS4OSziQXjNiEyj
2b6EtTKfd879mIaX5SCtcw3/b2cUw7aVZFeLDT/qRrnkznMX5pGbisfRKaJVTE6YCcdjCHujjnPh
yZQ2eVlfB/ZwbrUW6EnsGl6dQUc71Ul2dbucMe0nBczWpWanu8KIZ78bgspNwp1Bo1rYpevE/U5u
08tJn7F37wocMQHsqFn60fm/3J1Hk9xImJ7/ikJ3bMCbgy5AFcq1dzQXRNPBJJBwCfvr9wFJrcie
2WGMbtKFjDbVhUr7mdc4WhYF6ry0ZBteLXfSCM6lsXBN6moxxq+wYUNjmuePosN1xdbXi1FqIUFZ
E00+y2hQgdx3XSZisUFfZkee7ZEYnCsMw7OwZRPvG7fnpsHkgtCTYv1cEv8DlpHSvelL3t5eb/vV
r0JP8piBilOHYq7IC+uqW1rK99/z5n9VRPh/rbGEEgsS8CTL/32B4AJYYfytsfRfL/pZGTD+g6o5
EBUfLSYwvpuWwI/mEpUBgKkm394EZ9Cd/K25tBllgcvfmk4YzZv/pzKwNZcgAgFuRWhlU1H/N6UB
SgBvawOUBkHSoL+A6Bk0U+dNbaAskqJaXSERs2i7B2c7bLWhT09tV1BMW0mC63KXyaEP06XW45Ej
98Vzmi9odn0cF+tsDuqVQDnYOws6cg29C1b0aIW1Q9NgRv7uHkHelhrBdtSb/Wuaz1MMuyGsDQRd
qQemodZOt2lB9mfJ5GXyNt8hglTZV7hTWDlMjI2ZSFKzNCn3aGrcmsN8V9GojcaxnrYo+NrvcvOx
m861b5znokvPnZY9zzmU4O+3Uk6sJ01gOpock10y9F7oQt3Z8sshdLPkkxFMx8xtb+TsXM2eeA9c
mx1VpZfU3mS4q+FkoDOxHwNxldCNiwa3eTB1szrIokTOapjL47SWN+TJ5inRyovn1Vf+wp1E0eg6
p/g5ECzJNfFDijE1HpB1HeMAeVtoS7kH0J/sgcXcVSgBnW2u4qFbjsWoOQcULuQhKKq9L/qDV3sG
Rfh+pL9F6mq6L6rXw7ULoo4EMEQjISoCovXZsh7TdL5pG8Q97foBWOu+HZCQayFwrd0ph4QuG+vk
6+nVqFt7Px+uJq61ufW50fo0gk4XsRKeSpHwm633HPSVxMrQelm8oI4oC5QhTIED+vLP5mzGJFXa
Ua2mvF5su9wXuranr5HvE4uHmdLPopsBxa2HZotShMzMU9Y2REz9epJZ8lhRNJGVs4a2WK2IxtJO
9hZ5jt3ti4x8ovKApw/lrvTFSSPfN2V7bOkM5iXWlaI4SLpyu9QW+S4V/aVp08uEuDUWRlYQauTa
BHj1e8MgzRBSqZBOY9QZbkxE/DVH95YmYrJfR/DE+MuQIeXeISmGz6NNkWyLxowe0xcEhqOmEge7
RdSzNsqDjhJ+6K0I5rVjEcFMeC315WMwYSznI5e1DPJqLasXrRd3BAa3xJM7FKyeksoOExti0Syp
KRBGmQqyQWGgyQBkIC+49ibb/9SW1WH2BQVeaWqRbkiJeV6ehzi3nCd8JDF2f5hH84Re0pVVzydX
E1M4LiQsYkD7tEFuLmb9vCTSuyH4I/kZ3AfDRzpFTPWVBm1rL7v2KGariRLS3GUVaZR/j2AJYirl
kBKa1b6x08dGijhtakwsk3fTsqYMhfrUUsVu1uyzbWovi5Tt2UptlO3sz6vnvXa9uqRm9tnT6aFp
s/Nkdl75eXDzR6qFp9kzrixnuQLtRpm+RWVmQJp7aRF3yg/oc952sjl4Yr4PtK1nuQRXdTk/Z21x
n8Lvy1Hcac30vjG0B4JEmnEdDEwwsYGLCFoBECkRRkz9/ODqawFaM3hn4fg7ZBZBT/K6tixveIH3
HXK3TaKuVdMc14IavV4EEaHOEbzeSDrkHJOm/uKp8lT4X8ySS1Xv68fJIPjF4TokFASb1w1j7EsO
CTGoyFGuOpZTJyO3sgEodeMJeZsqbvBJ0NNLktY7euqkCB1rypTmE1+ISAzefumHCEL9B5ZoQpaN
0rRnV/uipetrcOC0mnYmG4kTyyxv28KQJ7dzYrcentq1fzan6nbEhi8ivTyI2mgjpasK6SBUuKaA
2BE217Ov4WOU51Ergnfc8DscZ69Huoc7f8yP1WUSu8B9CeRz5j8TEa6w0eu4MbJlp03W/ZgrDv+V
KIF0vJqRRu66gwqSXe8vn2uiaGWnfRgsrR3nfVAcezWbe6N0o60X5Mz5jV7MHYteEszm7gW8xXVF
/a0eciey2LphgfAyDZRnx5N3nsNmG9aCXWLS6FgShUB+b52cYfiQe86DXa4UUqqjYbl3pj28Gxyy
pMSiVpSkXRBWHcdaZUOf30CR6/ilry10RNPKCq26uB9mmPd16h6mHkt7gELP3STvg2bqeKfaiVyn
ep2yHPHgqruvMWOpVoo+psOR6y3ju2ngq95O61CXdU5QGZC4SCo+s3WedHnHUQCjTZveucJYH8c5
e+lt+clN3atAtp8X27xD3fs9x/mpS/RTOQZrWKJwUxjDi94NR3Po9QjK6ImQkN2cM9xU6eOyWYaQ
u4Mo1JV62FpjHenLfCYn+6S5WsYFRga/4ooI3fp6Mf3P5ThjnIDt0x6q7It0K2+XbeaPSdHczpPN
zUS/2kiDbxMC5PFiVgOnvIFYsczTfeG541Xdph/nSX/vFyVcr+rQ4aAZcrkJRHm8z6AXLhhw3eZw
71A91poYRl9D+RB8g5fKd9Io2hgds7vcWl4qXfs6GqgAI+dwshfjQS0uuHXXOyaBd4/82bVdq7uq
bF8p+z6Yq+GFvo/5nuFECi2enerni+8T6fvCO9YTjXKNmH9fzZgCedR9B9ASE1UNGmDmF68w75jO
Zw6u7kqI5igsQu0x8ZsIEMeDNzUjE6SvbHeOjMWdonqYv86p8aiSoo7AcV1U0NxwdQCcb5TPstD3
XVFQ8++Jq806zrXlvuyoFk09Rt92Le7AyZ2rxr/Pa+GwdAewkCNlwNVuacdN6acer6lwDLRbyxaf
e9M/Z0GShotci2siGsFhYzCHgfcOMHERqbWvQjxdMPbu8hDXtoe8qd4bFklaEZTHcZTAV2Ab7gGX
7H1jvKm2sEsNV2ZZ0tvov8HSP9ZoVoWZtL5VgNu0zr+MfraeqgZe2TDpB9uGc2alBkVoczCu8+aD
C/RsWMmEXHi3YjwpR78RKjhkamp3gQLY4hkrx0MfT9USl4vnwW5UJyelvmiI9WPu+p8Wo1KRl6Lk
Ojj67eKB2mzWD3XCPLlGwZ+uN0JNwZSI1960s4u1zBf6TllkBuODBdwDZ7LqYDW+ybrvWc7Susr7
yo5srbHCYBiaaK6r8SDbLI+Cynm1rLXcqXy6LiXuSaNL4UBY/aHyqbHb45SG7Vo8O351Wlr5uR3J
frogvwYCYkRGNamoU/nRteQUGxBhqE6JJw3aiOkkxYGDbNgnow2UcM7bfVrXOR0kSGxNWhZxZ9NU
8hHKjZQDg6YCeAR/LrQL47yMHQyAJH03ze0QI1VpHSxHmRR8xiKslJ7GmUMu56STGdZZGwn8Cfnc
ftRTupCe+Wo0klYAd0HcL+qGc+4yWuMVJ/nCkZhfo9P26pUbUhCPlBD8hhblC/GWKnaDniYhVlwk
viKXIYr2zr7ty1t3sex96fjPylwe3CH/MK3LtVnloMCKV2/wVNh5iqdB4Q4JPbp0jurxKQmQJXHb
hlAgKSkTomeyN1LvK3wId8+5mCPJudxO3Lh2WxwHu72GxquH/Tjdaoi57abWulczB7NBwWHqkJ61
KZT6s/L2g6Y9VmgRLbO6VKZ1pt5PfWiwvjTw6i7ePD2ujf/c2/6+0/xv04oyrTs7VKCbWNVJnLmN
2K1OVcfo47G1NA/lIa5wy6+taJJijrDfACsP/YdrafqwqDQabA9t4WC6Wjo9CTlMu1A1uO25S3LC
C+thWkAjtUNBvaArXsU8XBkGVXoUDhFnM6ebjR6HslBhR1a21RjTTY4HOXTRDvesPnLwxPyi2vo5
SeQJd0mkpqx9Q2k4spf1CcxEQjG+fZKAlPZisS69ubzXPNRpNUtgKTgvT2bSXc2F9VQl7q0v1ode
UgkG4Mq0Tk+on9P/MJxPfTBeY/M3gXSaz1ZRHhdnutiZdUrBZCCBURBxec5+KQio7Hq4G0sPXHal
fTXr9rqSBMNrswmFFMFt6qgqpA93mWQtIkwqTRZxuQPG5uyAFahIiOToaJREmuCk+vQbFKbhgITq
vuRWKTQK8klfO+e2mt4JH3BHmVYfUZnbO11w0mwAFLqvqkOFC/FZZO6NHRTlntELOYti/BauqebT
ZAn2VpO9r72ZU0dvhpNeAo7AEnYE3KAPNDMCNw31zDlhUo/gRZ0Px2Wgz9dwrJ4XXJ33Kimns9XJ
8+rMz0lrXxaLqlSbB6/jQOCKzRgBLsrL0HDPzUCjSZa9FiPzVhKm6Eu4sXBDFbBUexWcZ6r2MdDn
fKdPy/u+3CRPdecus4dwWPqCbpZJFkrpyFLVFfivF7+VlxxTH0wpLY+yi3i1GnajXXuwNLaeEkJG
Ww+MMHB0ws6SXVxo9C+1ooJl15V345r3qIIlYLSmNr/vMlDMZrZe7ME5Vw6yKmPLkThbGh5QaXfY
TB6jxCUd9VL9xsqquyxzXpWDYAAYtBuFI1PYosGlOW1Yb+84gb3x2lCs/g0K6sRbij8CFbbT2r3u
1+9N/ARI/FLa7BlVscIJJNHz8tFFS6aq8me262cIBbd0rckvcFIkKu++wPRqIm3NHl35ebHKd67V
wfqC+WUTW5PBYqy9zGJCb7SsYiFW42Nm1DJCTyLbu4a5sBA1etmiKXErNF6NrCGGM3hVlbs6dZfs
UW0tFwAaK/Yy/g7sjb5zF40EIqA8XxhRZee7xr2i2f++yO4rAkFVGhdHGg7mYPJpVRVNtIwybod3
H614w0yjPh+/+PV+XWiCj4Qg1imx1V0zIl6raF8kdOKyUTy41m0gizZqqd+EptftqqU/Nc1ytuv2
7OqUszXfifMEmxJKqRcM6inYwUmXCMZzTDscioO74I5l5tzo9r3S389Tm5zMxo4lSS6q1ydXDiq0
/fbdPAKuS9r1pfXgSVjLdcLpnUzLDbigLk4869YEmVcH3iGQFUXQ6V6KBIaoym/Wur7kvX4NNuxa
EYJlrnwGHvuE2txjIOoXYzKOfZap0DH6Ix2SfZYtT5QR7LAJ+jvIQgaRiUkUZE7lvjQ/JLUywgG9
Y5Ld4X1R3NBafe4qnG7SrBdH012+dCstkp7U1CYCS6YtjaeMLbCiDHUHF/tkdc3IaeYIZ8icxFie
xwBrhRU4ZJiyj0Mryc8KYqaWfLbMdxMH4ri29/m4ZAc8V95fKjdAU7q6HkfjrM+gFfQxuc3Q4sL4
LDkj9Mp5tliR42Zfe6+9anSfPnF10LamhO5QUh7wMPbATLj5+7V6bWkvNa+g6qJZCbnztDFWDTEJ
7d0I6i0XqZGcKgXOAGlhJ6kf5mGAz5UDeYaZ9bhYnnbRJyQXFHj/uEUAacvAbxbPfqqFT6mXsmvF
L0DB7oyjWLeQcl9a9RdnxRgJv9WbLvei1aTEP3TNES3bm6YPIiMZj27XPwEg6GK5vDqF8+q1nncS
87einE8FlQQcYdHGGNYbZ/VApWhfDJ7ona1DpNX997Jd6yMe71/qhE/hIyRws4BpDYH60V7Mpp3X
QldWOVyzcmPnNEFixJ6odimNXtIscBDY0kRTPWgHgzqfRT09qms2SiBz81uXTSlDtqFnTJUcTLsu
rkfH184O2hYXV1nGfjYoA0ymEDs70daoH5zHf181/v+TtLCJMP/3ZeUDLE9ZvsovvyLOtpf8KCpr
hgGmc4N1QY53wHxugio/qsqaZ/4Hjjvw1ylgejT5Nxr7T8CZD2fBg8gKXQuOO759/OgnZ8EJKFPD
qYUAgR7vvwScbSXjX7CYKNrCzYG+jyCSjtXQW3eH2lUL3B1s1tp5aIGIDP4sWEXAE0HXm31qaf4V
iEaMvem6TH5ymmjUtC8YklbNHyS9vys9/P4sHhQ5g8dAV4eG4BtQKti7og8gaV9TNHLNgo2pZxgr
kTRozyCZG/faEnWfgn9ShTeUB/Q1xuId3UCfWM3PQcaoStQnzQfOjnBubvn3vSbz9fTL9P5kffwP
OVR3Nf7N/f/6n38ZMnS9kAFAVw0LKgfRut8ReiPUzWTG9/Faw82OkmMwaPM1vSlrelfbMl9AR+VE
WFNnplA3DTdD+Kznnn337x8DdDEzt6k+/WXmrKWtF8Kq8rpKySA+ddYILtW0qgKRWPgIXjxManbB
GMkUpbNCH0t1TtVc+5/++TnecF6APn7HKcLqQgPC4VnejEdSqMK0oaGcK+QVM+Ps1kqo0FVwF/RL
k6er+aRyMfUhvkSaGUoJp/1UmPADMc7Wlz+o7vzd4+BDioAJDg+0ZQK2268sxzlwUtjllnduKtOT
90MKmZ/YakMagL8IemnH6TqJFFaIBuRzc9mxNYpGBiam4r5GBnL5Acr9jQ/+64J5+0ggRzd7TCtw
IX/qJhjP3x9Jcwqq7/mUxAkdKaSAvAopmfqEMbhIl33VG1IrI+ySx+1n5YjSMNQb1ZZebOddILXI
7Dql/qTAsM3LL9vNgnPKeQRbmy0FsOmt0FPjWPlCl36MK1WgF6qZqm3OGg7YZaTQ0LyZM1ZTaKeZ
5h+opMv0TzP1ezsL5xx6tADRHdM0TIsd9WZY6F9PVM+4Ug2tNdT17K8QZhAqcr7Y5qSX1wS4vbqj
W8S3KTKrlywVDVmrLAvnpCpjmK7Svsob6vu4IQFB0Of1w9qXFEX/eYlvxNhfR8rnZKZ9xyGOyysq
NW/6bh7Vg7pPFvqujeb6MRcwUl9mm/X99QbBeIQ7Ms7/dtHQZNSh/XIOInmNTM32UL+ydUtr1rwp
G+KhXnX/Bo+Y3H1OCoycbu2sn8hrDYjgjwB97fbo4Z9VXredA9FMmVVCfvnPQ/BmsZgO6GsbRig0
OgaAy+L3pymtJZ/mBL+2we3LekHltu3SQ6FSp4ITlNLPwvG7LJfeBEroVMU3R3Uakfo/P8XGmvh1
JgACwRXFOwxlok336e1OUpa2dmgIradkCTKZfER5rc+7K0fvA4RCMmAODQV7vaXBdOOhClVT37GD
JrOJMAE6JLRcprb4ptuQ3CK51EWxRJOm1bUZ0Y0HYL1HmGNZLqnyNPcVxp7f7zvfMSAcjAqbp1ds
M8btMyJcIl6pOfGvGppU+bt//qTGm1uGHjPHKZ6+weaZRvPhzfQj1jmJySr7eEVY8BY6GFDawcip
R6/VTE8rnbMRdba1645V1iKsQRHsviq63o0y31s/TJVI3K/wpdxrs9dLbW+7JZIYpissO0QH0aLy
QgdaRlaaK+3f3U3bw+P0gP8ClF+cETaa8q9r16C/MAV138UiGfzxXkwzGuqAImfr4KyzMl/Aca/z
7disef0NzhR8Plv4ztc/jOF21P++b1HWhvRJDIV7EJLBvz8GBEhdazlX43w28/MsLON+mCzTj4p0
bFNArOnkGUDZ4SFelbkq0gt9TNClAcTg+VC1WmJ/K2n2Tn+yWzTeHn0MkKMT2fF0DooU1ptLKgvs
oYCa0CDi5YzDuemnyYvSsi02iwzcEXf00xbrULZ08yORZENLSuPkaVwWduk92Tg7z/R+06V5LOtS
OLcz+jbilpOk+pMfwfdneTOKG4UpgCm0KRG8vVDpb1NDVv4QN71XPSuKkNmepsQIIw4CgjhXhkFb
h2iVrgTFOhpF7mLQ+YWBbbzzFqtSO8y3q4jUcwJO0DtZ7E3GMEMDNMj+7HaVlOQKrT+pZPVeBbng
jKZzMz6Qu7XUD3IYelAoR/eMlaKy63BsZq0AJ+ylOGp3c9o+oq49UDxobN7BkzWvAiu9Klgi/xXY
3/34zL9e5Nt6eTMSyBXhkQAJa+NhbYfkL0dySvzSNQhxxLOxLvm93pfI2JSA6p07i8lrke5x8itP
16rn/4s3hmWySV5iU7hlF7++sfKRFSKZHWKYg2LaBU7fHhCDTbNYr2Q7nO1cT0oCdEOp239+5785
hvCIZqnCVHE2eZ3f39mT5JNQGQeQmlTsHuF2eO+Cuau+rpVUwQcPmwAQdXODX1tF6EM7MulK8YfD
8G/GnaN+I1R/h+X4by6f2ipTW/MnFZe5Tr8eBWfIW5pj0AVq4JZO99QdfZRuRZr+4eb/u3d2yNu2
m5/+/FszDqOdm8n3GxUblgFCtx2TKvnWs6fRdQJKB1vCN3rUDv2g+9P9/7ueEdH0xnC3MaN0uHBh
JL25AGrggXKmFBp7zlBR03H7ect/QJ91zVAdKGMVBuVukz5XanhJeehHDSA/wUnSX2pdZ3D+eSn8
3Vh4SEyQmKEXgebj70uh6Cn0yGzqOQdq6VwJP2i+ln4VXLWmpjUg5GcXNd85G/4w+29CDwaCDBXO
lQkxC2bk25twbaQOQp+b0EEZzN8ts/Sfusbsn6YG+kgkprYpoy416xX6hqsV+3/+2G/T0u/vD+YL
tzGWAfH7m12fr0bemWvTx2JRJZj+FCPZ/Sg8EPN2gUSaoQudykthNg4sat/RbtH2ExeIVAjG425n
3Y4UsZBtE23XhxCuRjf+50f868xsw4MAn01zgv/ePOHQ+Qj+JRlPmOd4+Arh+sv7dTa0U0AdqX+v
TcLKd3Rquz9Mzd+NDak6ooZQ6Yjj3Tdrwq5gciKM38WNNbVPQ6rAIRRspiRyjcotcbyV8zsRKKsP
vaJ0L5Da5ZVrpOY9nPl1oLWKYF125dQiezUHer9/8rXZHuD3Ixv/RuTOULSHUAdu7vdFi13Mutro
nsYqX8Xn0UJEN3QWSa2bVjoY5Nwxiw85E/9gLUZxKlMM+yLLqNb2D0P114MU9qwJGdilAsQR/uZB
QCCNTdNUHYQKN9NYy1DIurCsTe0kzRrf1mVytlo1KphTc0ZvL9sXtp5aD/+8VN5YOW3HChElipfE
8NtqeXusBE2xOG2gtfHg1itKEWKwEJcYy6QIp6ACG++hlP+pbqfKC7FWSz5IQRwUL2Upr8XsrcWB
NS+fp8rw/mSV+D3jfDNZGNJhFwIb3vfITH+frAx5yhZsWRsTjbjWPhv98krTl+6m1TdUzuRUz4Mq
5LNWQzjbOZrqTPQzHHkw6qn62uUtMMM/DNdfDh8SVKwVHYtIHNb028Nn1se6Aajbxj7K/R1Agrp7
ToIeVJhjbFpI6+zbh6F080/+VM7XFNShA6ELQuojIZ75hHCYuMUjhzN2uLMHLwgHkmWvBJgBWguV
Hg+DGSR/eu6/3B7gV13v+0y7m0qm/ftQgp/sASW6ZYzdc0OH10Ock+6QATAdFk+/eA9qnpv5i7JS
KV7BzfvZHXZOc/fBEQaAcLOytOWPJst/fSricJe0ArQs+stvS2c27XLNgo8T0++tKfvPfTmQlKHG
4yM1lZS+ex6GXtO43RfiwpeyXr3xYZ2GxHXAFtZroeLZtmX9+M/T/N1P47eVR0GVm1bfzLrxjHmb
3ko3W0fwn8ke+dQOAINFBk3l00pHgVfi7I2OfazNJVvB+njYh75K3Zyo1iDN4fZwMh2+VegN2WAh
dHHD62bn2BjKUVe4ZU32eUGZrnNCrGCK+WgHSM9+gZ7f8lZt789a9YdL6y83gr/JhcNUhmXvuuym
36d/WYOc4q0e7FdU4eeYRqxeXzQlk24v/KnLaeEnFoDRAU9u+QdHW5DX/PVfRtNmDDehVE4ZkGvb
7f37uydmN1scJsVhaVpYerez6FcGK5i0mf8KciwkXmYtmEYoV9Zoe+NJcB0AL1vWQt667eSqD9P3
fBtTFvL1DIQI68QYsq3AMORlPWN9q8+pjm18o9J5OACbBvF1RAalWl9mOdfFN8trtPIJZdHV+VC0
3McwAa3RfQQV5gLimDW9XXzQJaRiAFvXMUkgVzSpXF+shXeod4EobaamX4sgCfYVIsE6m1sgpFaC
BekKTaEkEmCmvp+qWm+hSZdDWwYH+EOCly9LJygMcF5ub504a85XvmwTRAcrL9gWk0FeNQT7PCi3
pZNVkgpEk/lbPWEuAK8tcLPSvs8PKYxGFgsVfNQLH6rRcyf8p3t9XD4OmL6rd0aNCi7UApdiHof4
KPkai3e3hWqajJpWzFGKKHXlhpzkNq2kzGz5GFUrrS25zDSxyS6LhJHbDWOw/awRbu/edA4mWHyP
9A6/P+SnA6DAwlbYsccegz2Xt1rluoAPQTOlpn4oWrVQ3WxcGycCaEa20zjb/ORkdpdJM9lhd7ox
Ej3f/HzavGUhGfG6wqbx4gIJamyTXPJu8LQrWNT1JVkobcEXXjNDg10unZ7dmXS1wUdmGZVTfYGi
Tn3GyYMRmA0izqSmcToUOPqejRqTrZZ01QoY+tnCQDrY41JUMLAo9mPUQkpD7zsaM8TAXigZ9Oxw
4TbFtyAtCuap+bn36ylj0gXgUIYkke22gX9+VS/ryAB5+VLx6V0EWOoX1HlL58HvrXJ9GRvZqZvA
TdJvLq2B/rn016l5zUepz1eNMSPNvPGz0eXZQY3ZIAz5FGTMJd7t25vOGZYuVuQCE361W6fV4O5j
wo6kVLtss9UNgpPcKJF/eXZNilYxjMBxwgYrWwZEf8qCRy5/PHlmU/t69eoEwd2ww653au4bc9JE
cIB9Y/QAYIYV7dOdMXs+u0LV+nZO2wprMlxk/bR1bwKoY4F1Mqdlq1CLKUVT4azbMlDltVkHibWx
yLoeSaGqLOvLogwXdvSYeFN/NzrF6EKdzXVFzz4NxnW+akdNgbyh0rq2iKnDuxkP6HBYnAoZhsCB
E/mSm+Vpgl9Ps7wzwG/mquYEAkGgxAzszUTN9iPGIdsjF+wlgt65dlexRkUzTtVwJlniM8Zem9ds
LfRWnPFBL5uUMx6NfrG+NL6SjDX8ANaBqdvbr8EqYJ7jzHZqo7nzjXxlCZYmW6uJDTtPG2sPA1S4
2k0J4j5/WJtku0JyCQ7pWCSpYrF5jpAsNgcTIv4TYD4Zzh5sYPHtxy6z1Li9yCZ5Zt+aK87X+eNq
AWIOQoq7jXgdqgLHi9DBiI+9whGzTXqO2e52rNUda7XoCqt4b2gofB2DFeDgx5Gjz+p2mEmVwbGw
5zx5kKNZUTIU3HjolDZos37VZ9SGWEdpuu2L2cGr5FtKERbQfC6UO5oADMbttptSePYRDpHCug9w
rctfGnPQxcFoKdL7YZBRYVxC26qX4pETcAwejMVa+QkaW5tOWEa4W18lLTlQC8Pq+zytTkM7JuS3
dY72ah658H984DwTHkoITm5MwfWAsjf9v9Juhs8epMThHdDs3DN2jjXRGOzLRc566Ld4ngDWn5qh
2cNpdLQvdWe02rXRdVJAivcGv7tXGBIVR7eZsbtF1WlA2KsfVu0i1JCOGU6PhVUdx5S22Q2ocYNe
VpIIVey7UtMm4IBNnqQvgFZNHhhGDoXan1vCQhvrv+rBjB98gNCQZjo/56tXuxDZsq6rxc5cum0f
TWpYl0sbtIovkjrd6uVD6m1XpT/6xnJRXt6BUAoIlpbdLNG9OcGacJA0TBKtCh7g7va8lLL1zJzS
Fdn6SNOUAGxAyEvVDgbUkpLxwMGyKpdSMhDuK2sY8/yKBSvbUzeDXgwN3F2BBLBMfP/sBRrCVsiZ
FXR9I3w4tjOu6ZXJNWdxF2naDgZyX1JF/XGxEVw483jIGqtPe8qUnZHdle2cTJ/Wtd/u65+xkm0k
23H98y4XsJkIMKU2bfsoWzBVq/bs/a26/vP6xW1zCxR+XhJm4qRszc6wt3DpR+AFjn+7r0ZptbzM
U+52iFcDSjFJqK/GdhcXbb5dqnLqt/tTJmnOdJUgiLehsr1t6/+89WrLzJMhor+b5Ob/7nOA2d7O
Tc8FGQZMRU5wS3RGHZSt86MpV8rp+19WwMCmMKjnbT2kzrI1+qTva4xlUeoEMQr9cP4UIHTmCdXw
gi0LMCbr04dFT9ayey4w0dHcaNJF3cYgsPA2DzskAdiVrQ+Z3ML193tcSn985gN36RTIZdezB33r
XCR8XV+UQnzbiGf8KnkBPnhbPKArhyZjpCO8xlIyflx9wqu2dUNcs229XKLANu9HU3xvg/x4B0/o
0oZOu1B0QPUkRxLE3yEwIwTWtBZ6DmSG2IszLxUsn1Y9C7PTmvKl64btsAqSXNOLj5mZbKPerh5i
2k0EA2szSg6ddZk642ao0AjnbBzVtsyt2tiu5V6CwWri2pIwjm6WURhMui6C7VMQUZcMZMOSto+N
PlqrcWe2Jar4r6tsrc64TaUDd+ZS56Oja8CmJo2/LpGL04n94KEa4/eRkpm3vX8GST35mGtu35Yv
P8MCIxe5+tT0iz88L5plsRntJFNbobokJY3sSm3HcJ55+fbQjb3FhNaGkFCRm9kW/ae8QGTxBSI0
rPEjQHrBdPyMPXKzq/n91rC3D1llARHx4wR1e3zo0PVnMpGFlgn61OX2B5OuGvg4zjDUbCLQBNpM
aBUGfW+CWgs5MGobSzPTgj8LnkuHOZWEeYu5xLItt+1PeBXBbn3qGlXzaI7VK35zyXrEZQ5am/0n
dWeyHDeSbulXqRdAGgYH4Nj0IhAjGUEG52EDE0UJ8zw58PT3A6msllSVVV1mbbdvbzJTKVEMRgCO
fzjnOyV/jVHGUI7WpZXUzXAqP6/noi2Xjy709OUu+iEIqaLc4e+0cos6wIqHj2+HGoK/MmX0wbrE
rssi+d60UVObayr8cHaXK2T5MZOsgWe5HhPwJJdZFrYxjCE9TvV8g6XODa+o+1FquoPWFM9eFMj6
m+vx/fwecbLodh48kuJZVJnOXr9OFjUrEqu8qYa9odDLru08s9HlN4LKc52w6kmfkkivMa6pPJ7R
uEQ1Y84Swy3BMecyJbX6qS7g4BfrvonmBktRk5qUYUPNJ2Odoi6l7Vilnl3GKblkWH+Rm8eADrIH
FeL6zx7yuclrKIVoZ3q1BiuG7nFV90MOrlaxZCJJF8EIMt8044I68/fajC6iLgPFE3fR0DV+DTEQ
EjPvTYrpqhtkmVS3ElGOnm09PRtsIINeqmS/q4YyMDjsyNy4MQwGVt0+9drl++uhI1WyqbVy+ZXI
jErsg3RKc21DJE6fX1ftEOtyr+pOtvOFdKcOWxaFXIRAbG6bNA78GnpPbWzZDQYAXKoiKZM9USU6
ry2qC7a68cpTs8H2ByZDoTWnRhXLwTdyeS8nXlLyAA8+q+YfR3YVmwStralttIyT2HGWM551jmeg
OJXJlHxp28qOkOYFbR0Sqkk7lN8RE1ihhLNTAhNWkd3a3lNippJPduwz1+mwqc5GPp06Ixudla25
iJGxO1Z2RWa1G4+dfJKzwXXjxAEZgwgZjNg+YQhdytW8bJa2DXDB8pAD5rHcjmaCta1eWZ9/pNBD
gmlWLfL5Lluzil2aMhqQliPjsze1m2L5u0SrszFuCpu7NymUNatzECjRbrloPR7pXCgUk/NHe5J4
ycdzIeNrLvuKgG2+38RYxEJMunS6pgiXp7fDsdbHa28yAzCeDH6DJL76cVywwC54IvRVtZz6FH5B
Y8ClY4sZNcc2b9Ga3tInBhiNnFQkReOnRrz0K407LEf71GpLjZnIfHkAo2vnTuW8cjnZI9gOQfca
TA4WpLVTph81aZAvb8sPfYrulLRZcF6XA0+Ovcszox10fkISwAfeU7OolkV7kmtVMWzTXiRNunfI
+pvkjvCtSm3KXi/qG6uz8Ah2cc/bxqnBVWPrQWryXDUquDB/PsYLJ1GckZPtfLwvn22M1rahUYNV
cdpi3RAbBP9TaB0nmz57XGX+HHkzX2WViLj25uexTHJLSoP0WTh3ocfIptGsRcxQkBvKeZZ/Hnld
lHnUMz8erqBRCORYpbBDIAIUYc5EZVUGcuYarj4rn7gLljPPmjDPLYEXGMfooz7L9TDAOlgeSrY1
S0Mxod9mX28towZDqeVJJwE18ICQrbEUWnptzk25yWJtoUFUUzCZrxPcoHHe2bzBalxzhUjvThd1
V4brgtjy8Fsftl1w5w1Tne7nGLIiGLNEw4qy8rh+cLGKqBaTHzKiMBowDTKV3xgT6Pd1GdTqNRqt
RQcVhXyMO5EPcXUwhzCYHqsghZs6O7MFtqPqrPme0mqGcdOWHmbBi4lBM7CRJi3n9FHViaa/mEFu
FBtzIPVKY7iMxxY/otG38FXqkci1W8Axs0NkVmbFcs/cG8QveN5pSjddqcQXI8iUedCKrk7eks40
2CbMpbsrLAVW/qLL5sEh5XfQhrucjVxwPYTxcl+SM5TwpquaAu97MA9J6K2dVhaoXZEIOfQsWVrZ
+6nkxIJ1nxO5RfpvxzM9Pi2tWbDTAdIVBTMy3jmKR5z+UEnYNxrZ0Y7qdn770XH9qLIpA5aq53NI
8NmvaIiluZhEH9FVhl5FAe9aNO/omIH5StOPKtzPWIU+G/WQn7fEEbVc/+qzhjI/7yo1zYwbR6ZH
XB4x4sv0y2fLnRLwyTXyo879cUu49rCU1bWeL1W4ZgGWeWFsUL3VwxS7bFjE8rlvZ0tWI45WFNcV
dDS0VwOHtim5wtZRB732oxxZSus4qZfTok3nJoGCN8nkujSJPsJyoOklmJABBoGznkK1HBnMdJc+
SKNB4Nt7olLc/GmZB0szA1GTBrdOjZoStMcgizgy4BPGAj5VAfdMGvdG+J1zKePomqvJ8DZprWIV
+3RlY3bPLeWAP0Hq2OgjNCuUIpgApny84gOsxqswLeUMElC3Zp3xiVPjLUN9qdpv4MD79hu1RJ+8
RRLq8GOceAvmp22mLnnr8MSAE+pctFQpzwunEZACZn3pp+JpXHRmczEX02s15sv4SxVl5XxLkJDE
yS5o84E/JyAM87bpoVrO77IadJyNn8Mjl11+2SBVQ+GIj1urlrejgAzMQdpQMVAb1bHNL4ZWNs5V
ZwXLkwCiTMFH9eMM446TjCeiltAQCiTAYSl+PxuoycqwG5wa55pVJB+Y8/kc6nUr5+Vkn+V8o1tL
txFM7nJ8ecZMLQqdnJsCWxxGvXn950N6GTrxtpfpcg2khs0YxBnN3ml2kw24YWRoKivzWNhwoXhz
ar3k8857Kupghd13GWjUTtW2fDM2e2XtK9caoDo7tgq4MNUP4RVD4AxfqoaTGrD1bGSkU5k97khv
PX3OAHJ8a2JPRhNNtFYr7p+gINnF8T2jm7qD7IZBf5orqHxbRGqVc+XGlcnbJjNqrPtQGGDIfjxT
9aL6GJ6OCD2nTeAG1fQWCJgz/eJqGpc3LZx63utxCS0D4Cat5W2Cn6hxMsNMSGzQ0+EE+o5H4PLU
bLDBdDw1LcEw2Hc1M+fN0ONmcZ61qcr6YqM8K9AgBlZ9MY+XP2RhLGOXSoMBRMrh0PyY5TGHpXLo
OpCBnf+jWQyHoKWlyHsnn5GVFKNU9jquB8UF3A2TM+1c/MSSMnmaAo6TprXHZToUtkzEyEeoRj4X
o7McrPiMRmVoAs9Oln8VsuQ1McyrbVFwDUVQMTFmFMvcIdScpcDP44LPHcf+8gstKmxagNiNh7wj
7/xzUhOng2sded/L6irrmPd9m+MsJC7ENtR8JSJzBK4AXGVU5tPHeuY/AtL8HwTS/FXUzC/pS39p
UVhezVdmmn/mOf14df9PU5kW1f/fBUr/EEhz9wW509/O8bem+fY3DAh/O8V1/y37Ldlp+Tt+WBFs
5w+dQI9FywB+mk0rS+ofVgR+C6WeZPmKmBGd8t+NCML9Y5muungEWGCTj2b93YggnD/Y5LloE6X+
YVH4j1JCzA8Z7U9rI7b0aIx0h29CZJjLMuLXtZHQeisiZCnaRbPV7t0xxj6D5qbNj27c1cwVZx2w
7ARLHg+w70a3TH0v5yKQWzkkuyjjdxCrRXs7wTrZGdarvbA0e73eYHDsV7AyL0U+XzAm2eqlftdD
xRmb7LuoyA203Uu0Ixcc5fR9uidXsUreWQwdRk88yqhEHx6obmP2JT0pta5Ref7yH0lop8RHRpUv
VPiWY0PYkwA6+Gjp1Gqw3LfZAM6aetomWKYr9SC1TaqH2ZrS6YYf+MoSxWusm3scvfo6CYJw3dox
aREWFFyB9wjDarkmh2o+zdNMBmeW0nFhCPTYsPlenHyXTG9RT+IoDO36OavyV6/MN4URXHQ9sosx
CfA5u1sj4tvj73zTsXzuEORByDGK6vNlxa2ZrZCx7bKhqHx4qQ9Y4FVlnedZpht60ddxcuAPM2Jt
u/idppzjllcyo1hYFw5usbjTH/NoqM6iBpyjCc5UheEZP16/7t3kHbkiPO/0rcnDnEmAoPYgqEGU
xlPeanTM4+vgTI9tyycXp44Cohu9jbN7mGUC9cRsKiSHeBjbACLWDHAjarpNXmRnzZuf5pH3ybT5
jBCBrpiS3PRddU6RivnJxM+TerPnjxLamzkvSyTj2Ki+u2CCOdVjvc1d+YxS1C8zECHZAArJjHs2
tbPuK/Hi6vAkRsgNbFZAdpbxW9Cq6VJqWbUJe5OEwEmkF1HJc8hzMZHNk7hxiP5InKH3Y0OjQ2tV
dogZHt2KxOq2dIiMKm1LXWQB3WubMl1sG7HGdqtguzAXK0hcZto6sA3lRE8Lb/I1r+82tt639/Rm
ikrCQpfcgUjnZo59RiHlqhDBRdLorFOU2CmiJlaxsHZaBt/JwTI3ueB0YL8OfsY0bBXNXOyO3a/c
ytiMluFbiXdA0rEWRvE6sy1Z089uERZfGCK9zZLm7Op8+lHdnXPmcWGyJdD09afT65/IKxd5xy/3
v/QcXV+MNTb9qW38Jv8AmFGKsHfDnczAE7qlvZsSZ8/ekHRtkf0798HvyiAQ+px2SPsx8+icOb99
t6E3DI1M1HBHHgcj/tDbNW6/08riGevRHKRXow3HlcqYC7J9/tc/qfG7EOLjm3OoOjZydpOf99ej
rsgNqyQMONwh83uzbL1cO0RwmETSsW3krPn4IHLwjEF2lEV+1GZ3+69fwu8KgeUVGEij9eWkRar9
245+ER4ykDNCllHDSZj5MYycQ11Db4IKVQbpv3m7XR4Tv3+4WNx4XiAM/6Co//YTW3rbsPwLdwEt
OfsIZOrTY5NedxW3fIOji3Gmdy/S2vMje3xMhAPv582s2WvYoZ92wFqCeGt3BRpt8eiV2jrvL+tk
eJSl3PZmureq+ir36t38zrym8IkzYWxdbYwF5EWwyk0xSbmaR/dQlfGXZGwPQElhwUYbTiOs1dE3
p1Y0kn32qjIYg5VlHLFYNT4vHMH80G2S2kDmzLCS5PkvteXd52x3V6luNZcmoFR/GMW7WzfPxBgT
pcMjbFf1xk0ksGRkHgPuLGScz5b4EbXLfShh80zyPpr1x4l15Cpu5JUJSNsvZXRBuM62rGCOE/X1
qQz6v11L/WWZ9HOV9L/+quL6H1hL2YhU/rqU8suWyMtb8v1+dnEuX/OjdJIEXOL5MxC+Wlgm0eT+
vXSS7h+4zDivoCEZ0v3fpRPOT74AhyfVjEus7HKX/+nh/EOQd02eAFUQfwQl+X8Q5vG7bo5AQdx3
S6Ar1ZhO/bbc6z/p0rV87jFAeel2LHHrr6TO1crKt7nQOjp58CtTua6jzLxqWONsNM2J1lkpNHyC
SfmWNm318tN7908O8t+PN0ycmC0EcYOCoo7Kkffk5xc0o3EU6SDdDQ5F4z5qpXVoHKCdxA2P54L9
425wYmBhJhvKmuXXU2G6OvD7Zr7/16/E+V2LhPzIk0TCWjaCQt7y371bTCsz4pqJ2wIagT9B5gvn
aigPxRQal0iO3yHSK1812Ah8iXFhpyCXXsqI1Df0qPpxhlFwtmFG+9NsWc9mAOmvblS+nWODgKgi
2/ZRx4A4Rhhz6lzoqq0z6fDh9dva7r4GrEw2ZTb0R0ES6IlNTgQqYNIv8Ap3QFutXK7KJm7Oba+0
Wzcqiyszd+1LrwfOGBgV+ozMc8zvlhLOLk/74DJjXnVCqe/iXc8WlXG7G/W5BIya97vREl9p7lCy
lOkrL8Taa3Y0vQ/dXPiqxfddtQIQmxsC58ouATqKx4ypCWHHufqSGiLaqugqy2Tn17r11dXSFyeB
CBNVDyP+p22N7Mw3i/iEejEDOAUGIoM9dhMGbMZcxRvstQZ54+hWV7pRT5uxbdrTXNvz2hoDtSUg
on0oxoKJi1e0B2ofxBuZYR3QEKPmUGJiRWsC2zdSoA5jCZutG0B8s6rHs598zWsJOAGIhH4d9Np4
MxoJR3VpBXAnGK5+K+YwXI25HkEPH1ITxxHIMToFpjtfMngd2QWX7lEzojjYN56BamU+Ok65R50J
bHh4rGz92XH5+KqwBlAWwZHSnPxNm5oLq42+O6bzWtZRt0kzeNQeE1RA6JmOH6VscNi2DrQTWayV
k30lrD4h5AJZhVeOByLdSJJhh3MqAOvsejsmoWMSCK4gwoBViR7MWAKoEZ2GXIwn1zAbflRab8wa
tq0y9AM+oXyNUQsRBmi5e9ejs0nJoo2yqNpr1fSe5CHRcSNse1IUmp2pjTo75uibkVT7ciqekeAZ
KzMJuj17A0ZpadKxG7LvGBL1K5FhIdRQ0syuzCkQ3WtrLnm4aVLWB73T9U2qqltwZ6AgcACT+tDo
Z3Ztk9r2MvC2S+zCOQzCaT/NvfdAycNHWiPRmitdi5E4gpEImKVel06qII1hY/Hl5FaXRtM65yIr
hmPRjc1yJTej2FRuCkGoN5murXsNAQ9g6DG6XPzOa4Qm1KaMd8Ba9hOBYXp6o9XOTrOXa3BOheae
WHKz0AJX5gSXjjdU0XU5EHbhx7nDtGPF/tCcF2iHp1ZKUCMusHpl3OilDaMeLc1UYrpQvBwxksCx
6mV6jXlX2WH6TDd2oL+812MY6R3TZ78LQLzgDGDqSSNCLsus80ej6sISo307JTMDHkSW1MvU9PBT
G1rF0vyCVsj4woGXnhsbXQxMF1c/DHTbrDLSyX7NwTR805HX33iy1++1ISxOVpB3dCaBW79rJUP+
0kzrrUbzvsqaaVg1ehWxDgOXVCtl0kCT05JIvTwEQRyt3aybd9aYAZCDTBHvpUdExATvcjUqvX2Y
YsfbSW/YmwYMZnOM3e9px+NjrRtj+1IWQ30XFTR/fjPkyPiairn9XBkLS5yOffBcDzieWDBNdkFy
iV4WTOOtwQde0e0bsxlR5zgqvS24wjjTuFzPubLx9KatBoBtoPPf9raWHDDNBenj7I2OvE9Q4sud
MmQDL0SyNK2+zRJpyQrdmhFcxYJUEs9rJ751R3KixbXJGq+o7BOmEc/PGXE5jy6rsfvALY7mFIhr
dpzFWdpjg3MshKshUmE8T+a8iVmij35TNP3XMcNfRFCXdUggjrGqhqEqDAJNysqrLJ5YybgG2DVu
kr41fKnH4mBVLrquoocTVLcKYKwXqIs+sMiEB9ph3C+Kh2BVDwhiViy58ZPqjVLn0A5fLRV4hd9M
cuacKIJjncIUx6wRMASPe9OCk54kXyfXvsMMTgD9zGDwzIAOri492dntIu/IdDpi9lxEWrNhmWrc
wzg2IKTxhzyZ2YcxaFkxDxwYOvRedqFpfxfJZtyjh87vwinP7pASnLnfx0PE+3/qRT8hmAj05hTa
briJW82g39VGH/Z5to/zHhx6UoRfbNiQO9UMXODDnN+y3AVXVzPVgKHlyqOXWIdqtGiILQwQ92yP
rBeWYFaP1Iux7l2s1cLvjCnchuUAugDfu5Ny9MkGCHgjqpMbCecJmVq9BGMvWBPeYlJHMrb+hWu3
93WXh8O67pG28V/1bmyiHC1L6h3HskpvrAIxu4sCqfe9sXFuUHpjUyTqcJED1IXchOQOXBdOTVLL
QL9sOKwENwjcslutCDemrNIHu8ztcG9PJcfAoLr7fHKPSgzWlotQP0yxZFQ8D/nGy5gRrfVhLAdf
G/v+fkJaeQ6TZr4phhIq3mzpO1wx8zE3Ku2xrXLyUxDMYjMlY6QJ7AtjnMcNdNz6JZtZmcC5tF7M
rhx9lk/evgzwEIRpVNy3TVK/hLXunKJcr86TzIarRGs8QI6i33Ese7yn3HchavztxGMDljlDebJm
eO2ryehPRZAAdAI489w4XnrbR9SEpT42m3Bugss5ld0dQyeAPk6vLzyaTLMOETLaadMnPWivyG3r
FZbx6sWDmXgMxvpeLxLkrII9Ub3IH7gZJGZOk0edlpTRGWivnq0D0dZbAhKBoZHn9OAYxTDzR03n
xmINAXoom/KnBO9S5DtZbl/YEXqzAa26j0C/5NnvdLJhtTdzN7H2bSDcMCRdW63VviMLDEmfcTa1
26RboSXBGQCS3I6V3fokb0MPRex5WggN7xEjOX39cQ+ac8bFEhUOy35hk7gCxQrdZqxfJks4pQwn
fU+kJfKe2lDrKRqyCxV71cvHARHGAJkTbFYv82JOy2CtXlVGnVtUcDp3WpAW8WEytEj4XFnlhnjh
JWB7wNpzMY9WL056mZn3TZfTew6xeZ/1rQAezDtLXo2XSKu7C+hl30mc4yhAZ80xIzt1nhVApIeo
mkDHe0nE4gS7B/ca/FTymWTDBc8mTu1aYADRgiZW54/Hcg0UPGftVHvfiyj0jl4p2/ei1b2+BLwl
jPuUjCuk9mPJ4MsDk8Ri2zWGJW2E/CkfvEKiQOqF0xl0MLskaYykANjS11kZnxEG5d4KybZ3tK2u
eiEeqj0FnjHA1quFOn/8TyoNLsjEtvinE1QW+OdxrF4iqG7DuuxtGcODtvkBSjFxvrH4zUmPqZyv
kZ2n3x0rFQeVFXyZgN4LQjZU4WZUhjrroNpeZDpVz6x4uD49N5mNtdE5/JYzVC8otPXzQOW/qxTZ
siyhJVTInqjMVYsIGtDhkI+XzZJ1uxFABHx2RPxfKfrw7GGt/3z7kSt718KuP1uV/7bG/H9gz+2x
X/jrnpsw8+5b/iX7peVevuTPllvSPtMmS+zH+L1+wvFrnvmHCZJCR51s4ySi0fz7vsJw/yCAVbdJ
GjdtHG4/RWiSag7QhXEX0B6BPUr8R1F9ePV/HWkZcF4drHwur00IVBO/dbkpiAW0h8UCGlfxpuC2
h8vZpWuqjrNOuOOmM+zcT5Pwu0yM4l53yYVDunCjAncPeKJZmxGuUqGKkAEViR2BTW6GmbojVN3W
3QRptBuZ9LLCD8fcLw3rzZyBBU+C1OR+Gl/LBD0alks21XZ/lLGIFxmU7QtLv0nl8FzkVFpeMIIp
pfoK04FNu5LDpp4mOK5j/d1mK7wJ2bCv2Br6s1ulu6FacCaavRXCo8dp+wkOvQRE2Ec98LTWwqPP
KJymo2j7kIQX/T6E70dgh2uts0jKp86r9W6NY7tg5NUkPPhdI/06dVV3nJCDb/ltkBSDmm6qBOn3
ymohYwax1a5lmoNDGwOMvH0Mv6MyrhTv5QnrXQEJp7oYaoosSyIpRPPEeVpH4Qr5d3tJ4Ri7qyKq
yx2LE/u1BlC6bmhcTonRXFWJ8aAHBkhXlrE7GMjhd5Th6Pwqz7sqwwji6ASEmNPW5PTI2rUBBWiV
5inRKoRO7ce0rlgGj89hHp8EIcBbkQv7AZ/Hgw2GaF+Pengqoj4/tIU0v5RNkYVrUn4ECfN29JqN
HdFixmzSu6VDe2Gr7EUfnendduv2GIvMObSGMz2Xtda+gf78os9TIaD0CViArlUTx42hatil89QT
Kud640yPCy8CVHd8GKF+XntZhJHMhneIp0Nj3l/U9wi2Y79yWuKgKS/bysyeZ0ESnEzBNQx4mS4l
Fvb3EPMwgkcnfSdfgZqeWK7evIFNaGmnDqlZtwcR3qFVT1XOY77DX407J72Y8XDYiKUD4hpVk2VA
CXQ0miqsiz1qkqB6CmSWApudzOI2CjP6KFN1tI8jUvOS4cdxDm3r2Bf9Lc8ltbHBVxF44tLGzBFP
k0Y+OWN25bFGQ387+cROPpkdkhFkgaTtgAi1mumO6lHc0Y2nl24ZweI16hSvfN9OCLlpnqbpqcII
Wz8PROSc7NqS+65hOEbSNnEy2hhvY4LPviKaTKo1FcF852CfJxuHDzAMnelJD/C7qzHv7pKxK455
bgf3aGCQlWtuwapf2ZLhL1qBPpEDTWNt3qZlk12rNs6fcRRbb1lf6iAh5gSXSD8l5bU5ETbrF7kV
b1nxa09lzuOpxypAcWPWHfd+Qoo3n6GW7BhLlAT9tDeMp76DdNf9aSwX7SctnyOJWZgNAwhAbPUX
MW0Ik+n8OguC51RXa20ge0Abr+uSZYKyRQqK3on3NewGZGQKYIxFKtEANz0hKoddWr+2Cg2VChko
viiEujeAz1In+q3bmJsiD7d9Emq3AAyvzKR9D3Sr+9ZFTbXtY6jYdEgiDWByC4NI0oe0dWQUH5tQ
y7L2qoLHY0+bcMRKN21aRocxtaodmB46IxaBj/gYL+fAsb5aTZq+M8Bynu2ycM5BG4mLujZYGHQs
IzWmAsi9AL2xBNPgRe3rWuR7KDgMK0hbJmoxtr92HU1WojzQikFFJOrgbTJh0PGHEUFNUWBdFdqt
U7eTA5oVzJ3gfDz1NebrrEiSoyfT6CXxuuDaqiHpB3EennoGfQRSEnqyjRrNucqJBaw3rWZt7XI+
qhE/ReBeyr4pV0oVb+bE/EP3yGMnwmnVV71vommiD2/uVJgZ69bTb+xZXQYowtYjMEzfwn4Es1ip
rZbW6UVZv9QKxLdlD6sQVPxlMdXy3GRBvOmjariGS49Mg8DvR3pAcp6yJTAVjS6VupEsSqiO2AE9
Jfqo1JWrVoHr5jvDgIy9CXIoyc38NbPFjaqISWaiMw6HClnYuogj6/sAk1jLiILS+mG6Wc5M1pXO
idXpsLdn45LPiyGgw1whLmLkmnXNTEJF5b3DNMKNSYWQmVaQ6airdxP57nZsGfJ42BMvVBfjvmSf
6TJjubccBpUlmDq/Yk+1nhp33FRmE+5zWEwbrt/KN2Jggaui0++yRitvh1Yh9lL1s65J0p3rxIWr
G75zTm1VjZC31rnjStUQmdl7ObvTqJ7vOsN7tEOAeJDntlQH8KiH7CnERbAqhR2uLRiIvsJmfg5N
1tmkAnZ+xoCoaYIjyJ2JNGcSBGUYSmzBmb515nGXu1mxLlW3C1CRbaLcG687YDaNmT6IbAh3dTHA
za9rBZ04lduWZ+U9mWQPgaghF7MhWpepezeM8/M8jOnd0CY1rdE4HBF653sxAFovVR9tez0o1tQg
CPdE6FtNsjNi2OMYXq9azJwbA+jtJWlu3krEajp0pIJcRtI09qRSgegVPMd0grFW5bhMVqmHN/HE
AAzTu89L1FFzaTdS7xuOlAkUVBJcp4FxlbqUH2XfIt8VJAtJd2DF5WAXzkmtdJqZk6pLg/tezduk
F88zEZC4ALS6vo2WroQHUGvaibiwhkgQeWVFQBRX5mRAE2a4oLuPWhamSBXlYK6xm8huEYAX1yTt
XBeGuTUpMdKseOTotlfCWbC8QwfBNNaKTQdxeSsCc98Vg3gyOpPkjDbaK887mW59g+tg9I1hOlml
YHUHk7hynFOJ589BgV404ZruBs9XfAiZ9BAxKaEck86WjABv4yceq19I9t4kaBnJ70ydFR7es1TM
haa6odZyNpMOfnYmPawIIoaLE6k48QaXITD15mtfhdEpHDx1p43RmVL0NiZOYRu5hrPX0lJfm21K
rJvF085ZZ2oAj+uiQrSIGvxKjp9xVwHic7OlTosSFCtjYD/YYxWtWUBM6xAZ6d1osjEwR++b7fXF
qTdaDhklvio64i18geZGw7PGQyToqusqTY5ETOsMDXsxjGaEoHyKE5L9KLw3VS9tpGJlGcXzqQGg
ApNZqjIlfIV1yintaR0T1PCwuw6a143jirE5TGcxRckA1GOMva/T1CJRX320Af9tndD/rytKWpJ/
1S/ty+K9b760P28oP77kz37J+sOwhIfhFUDpr/2S9P5gN6jrbPx/13fRLzGoWNgoxtLEuMsu78eS
0jD/YGPGcwp4isdHTpf1n2wpF0HFT/IOG1GHC4xgGQZYwuHl/LoUBKbaZ1HqOFs1jdMG18OKaYt9
Cdz5xtLYsWcOMYKBo68YAKBweWKmBFAozM3DoBhrwvtez5RNcA/j25/ex3+yr/wA5Pzy0nBOC5Be
iOOgJTAw//Wl4X0YzU5wbs+jEbwsdjDWQXkaFj7TiXSHsjJUeHjbnLiXWc+OzGYK8rNxxh/0QJvu
5hilQW317b0WDS07rbIVa6EZFG+M9M5m1xmkdoVRfE7KGXZ52wRiwAGbm28xC7Zu3ZdB8I1tpLfE
aDXMXwLO4aMmRHP41z/qB/Putx/VceCnIANFivEPq1kcWVaOkIs6hmnJPabSbsRNSq2BLdfdO3Ef
36Famg9SS7Vdo/XxS25XJL62U0SjkBdufNI6M7mOA3tJkPfkO3tvg7Ks2vybV7q0z7+9UgAm6OD4
YPjXsnH/eYmMaNtEiRdHOzKH1DnJgc9J29s0EZcFG9/xemBm/qAi1WwxbYnr2avkIcFou07LLuxJ
5zEVSDnSRh2Mhv9GPvM70xUWlGUIHekMG3dvYQz++uoISHEy+gZc9lXb3ZVdrdbIJKVP5GW+z9HK
PupTes1iLbhoDSRndjsa/0ZTI81/uKUEwdsmKyqP18Fs47dbCnOeJ5wmtLZu62jZqWAASkJHLivY
QelzyD5mDe5/8hna4QK3W8GyoiQKLXyY+4bs4KYwLtN6NinJR/2oLZiGehxJPJ3LVRsO5S2dd2Wv
Sg0rGJhBxoi2eSabc9wpYdBdJq8TdigSofXksbTJbOYxnj62aGz93B122WgKnwDse6bL1QmkUIpm
3pwHAv36+D6ygCkgvDKHYkcIyJfEDg2ECamZbQMNOZ/PKqFYO0EfPWBeJMWN3NYYIaRcseUkfr5A
qoZ5KhwOZUNcLpmHne4nrS2femynrIuDjkwEl6jMVTZU3tYb9I1nJPcuLFmi0OGnIMwXX0eIPa/S
SGsy9wJqI8aFlIR4JmhElcu9XGfjZsRSWK6qCMwQPiDDR4tv+zFu9PXYNQEiuoRxItSM+JGhL+Ev
oTPuZ5XXrx6r5ystz0CKVnLadSbxgfABYhIyVLnXRN1+If8WWkFcHKWcu209DfkF1kiiH5iMMFDK
mkPelleqgAbfouBmU4ratXQyh8Y5ydfVoCGOdBbZLACQoyvM6BsMhpTdRT0c/ou9M1mOW8my7b+8
OZ6hd2DwJhGBaMlg305gpCihBxy9A19fC6ocSJRMtJy/SVqVZd6LIBr34+fsvTaGuDvLQZ9QNDSE
TDIKPBGOO72f5meRVzIoKte/ymu/2STjkNBLan3/tRvDF0ZB1/OkE8A39I51X6GkXzOVuocDK0mZ
JOztPh2JfIlymcYnaC5YQVERMKo1DFAMDE8GDUjgitQIH+pjos4EPLRMPBqzuHMnJoVTabg7LB3M
j1R3NxWy2maipvfcRvUKNQ755ZHf38dx6m84NU39evIGtSI/BtVlwkNUZhVvacobB47pyXejnZw1
RlX0a6NHs7dizliNL3nsa981VP+Ur21MC7p6VbFB9BswAgbG+hi4qUvUre1/06YuqEPl018emyuI
v+8U2OZa+RL6hLC0dcUMBXnsEDha7AS5yyEQYk27IeDnW9Eq8zTM2s2Sf5eHTnudUefbjdsf8iUs
ka8x3Nr9EhydO9eOEc67sY7PBfiJbZwn3ndEft+0gRErUTIlemMQHmlSZOveT3hiZtKszaoj/SMO
CaHCdHNSQxj/oA3SnllrdAIU+9gkMKiLVpWRuVsjrIZ9MkM2XVdzY2xiO5oOzdhwvJP+d7bqdtU6
UbfmnRyv5JTN2yxNunvYnv4KH4d9XVtOUE6zEZAGs6RRE+ODd3qyLpy6yYqVUyZ6wK6hXotS+e8W
QroDw2D3mUGE/UoiFNRd304uyKnUrXWfYyYDueoj0G7n28r05zOT3WKXw3288kh9muT0FJHYzoHU
dy6YYgIRFU641WRlPzbW3N7FcXgk4Wg+VkUR3mTgyC5w1Vvkbbh7Yx6SNUwBFyWzYRJd5ad0M5zU
Iw1NVnH/I+MbfQXbgWIkzE0aJcwN9qCgxHZxM6ytKT1M1YgyOwJy1jUkizMVUPKpL5lhpsXI55bb
xz6f+h+6M49nThhN4MxNOaOXhD+9itwsvcaUra3pGz+ncrpoIFwfMPCUG8/CQMtouz7GbjEEBbDK
02LEPHtz5D4lqJeQLI6qPGEttDk0Ji+kWq0zolFvNenVZzuK8j3n1j5eFWN5NASx7QLo+v1YzoSj
crNuMX4uSvG23bpuTAmlM1f2VwSug0qLkqso7q1tJZKnynbBzRna0MpNMfTzTWpjqu2iAQ+4XRoN
gDf0FJXomqMOXXlDK7skIMQv1oK4Z1KQopwJVpff1EkLQE4U8aEw6vR5TI3kQc9K/cdC9ADPWrxn
cKhOAuMi4ALNucc0BxIw8s2DMYLWceu7PveBIPk9tMKlooojWW7joqgvoyktDxkIFdQ9UlzWgqlt
iYD0KnWLm2LuEIhWnMcN945tKj5alkLw0fTqgK1oq5uVPLrNeJG67ZWYHCvg+HuWtKlWWls56yxp
moOQBX0xvM77DDrHCYv6kQbbTdnnkHe8Ua4qd0R1CuRBuxmczFth5AnXFuY0xoZJvA3T8L2cQuL6
ULesMVzn+2gCQNoP8qmpCajH6CsfEsLnA4aiRExb4Bexwzq7RJgDg047PZWurdYWkVB76AARH6ht
Bsof4gOGTXFjd168iYmH2xY5mgrz58zda+wrUDCMI2ub95udb9iTlAtvkorvARbPHRgp8aFM7ZLk
hAcASGptTOF1PQwyaJjo/pjsgvkvs7PLNBToQEik5vgfEsE2qMT5jp8r/0E03HiGR0/wIvlIoOxQ
JmMX0K/Beck2yIi3xulKhP28EprkgNgOoUKFEXUsX8A0zX7lRWrwLgYOrc1W6wloODWwjrSg9CK3
RAkx6XaQQaYydt2gKk7lPTp56w7PYkNbPwnzMtxhios3o5aUJrL+rolWOQ33fIfJq/hWsjmBPB/S
UZxcSAR4n7xybj8KS9DMxVxHj0PnBar2pS8bm5Ef7oc7Gm7FBSbTnvXJp2E84JbqQA5YlbuP6lYD
V4SAOTrouqqJnR2tZrzpab4xxE7oXq2laOlUMny6hN0Q/cBv4pNvhyL4zqyor8685qTheo3ctSou
Lxym42cwG9wPk7F8hmJwCdoVUTpcCM81CwiuU/tkG7nx0DfMX0j7y8+yxLkeTA7GiKTw3/Sss/aN
qKygTD2BN4T5pOCDlXEWMPmBojnoEaOCDCuA1cd20M8TyPyhxWS5biyh6FIVigAofVCMRQClVgFE
A9IpsNYyWeq6Ln0QmZ1r14XdkxLZu9F1HyfZdphG4oxHchxQmFqX8HmNC1hb4QtgGo4qnSkyuRnE
UE2EFSWsTQSytZeRksRa0YAIj1qhh8eMzgxxUHZbHmTpjnfWYNdkUffw8EydXgVZVeYe/+X0zh2g
TuvLUFKDpu5thUH5GCcDtdlcjFRPytiGczkA5gDoDbPHaNZNmCTXphlaTxUNo1dqbSvgfzK/a5aY
sf5FpU8BW4nvSEFisRZJa9+JYrxrlhlCX5WPBQFcm9BPnhLu2zpk4ED4yBnO/lO7TCJmGx81pWi8
JslABWbW3g71YF1U5cQMY5lm9Ek9rrpSJxzOdOvyNmSVTfepOXsMQUaCtPbYP8O1UWP7ATvDwKR0
YGNB1XLSYxHDoglsASziQuYzHo0Qq8jeyHpDu4xDMB03yezHiK1gAX3gRiK6ifLyg856fdK9od/Q
MiOkdJnvxAx6qmXiQ5Y3eZaOK++1Cj8L44z6KAmPWoG49K+0IWVu1DVMkCbJMAlPFYMlY5kxuT/H
TenP0dP8cwxlmuXbOI7tu4fO6jleplW2YG7VZs30kafpi1pmWtXP8VZcSXSobRO/uknFAXiG0bTR
5858S8OcZEezji47FMp74lIforpxHqxlmjb20SW8F/lsDBQHpaJa2Liyr960LnZDztG5/lB6LGvr
lqgkmHuwc0h9cmNFewogwEchi2s919Iz329xKZVJCGjPz4+Y8FnWRjNolMMvcKhtXO8Hbix3Q6Tk
cZADktpMP6LJILvah1p4mVEiB7FTd1e1UeAzkraTb2yaFdEqLPMlO7D15AdaObGShb0h9asChFHh
w8y8cnwFXIGqxOtuwPbxj5SMYTd6WoZPREdWhIGWXrdjFCM3QoHjmCrGqIsUMRdsqTHmgVVFwCHC
lkFbR4lfXHi0i5XvYaUnAnRtLAwiSDPf0ROrK4B9B/ZdVrmw7H4kCCC6lRSD5+971ya8u9E6l6Dw
sqv2nU1EQ5DnI5pXMWX1LjK6uT1IW7aX3PMfpZ7Q/vUnZ29V5Noy+wsa+EErD4XS2FrxQXP8DvVM
cTN2CYHYmfcU1fUM+qKmmLSat6iNCAlDhrJ2Bhnehyq/ydLMuFSFKB88c67BnjrZ9BwlfJUomu0Q
pZdfbN08V++sKPNuINWKoTbKaVqnB85YBKTL0VkBDDZObe/FB9Lou02IzY9BVeTROEJRzctPjzhy
NfZXn5SHnGpnnaQifczHOF07NSUnxTchuVUR7ynpspPdRPqq7tR4jzXokKvuogEUdTchLV+ZeYFb
WLqLPKWpygc5V3ARlCBmOo1bB3airVl3ncqWVnFvkk5oQ55ZKfSNp9ieWORrVnN/Mpwz+EYTor+y
gta0ohd2HLqv6WDuGhzyADkHfWNXrnij+f4oc1ec3SxM34usaE/FSAgh86CYkrU9kGF6B/08ewnj
AYce1uToQFRw+q2jVn6KlTduE3eMHilstVPl98bFQmt76+G5XBFp2m50K2HD5Zdl8UF2CfmibWlR
PqDw/aaPEM9WxiS9bUHM77DW2QwORAwYF66lmxtEqoTWpWb6/Wdz5/+3eO8n+f3//Z9vVV92zXT7
PUp+d+MiB/ilC/aHo/f6rXwrftPD/PwH/tPgFVhxBfEUrs2Qf1G20BH7j32XuDCdhAYd/yy5OsZP
rcx/ksT8/+vaNDnAGJu2Swtp6Qj+p8HLvw8Higfv1sLSgv33v2rwmktD7teGHcAemlDLf9Dkpdpc
9DK/2FBKR/it7Ss7qLs43vqObdyZYqIRMpNUbHrKpBEydIdhnlCyhaXp3/rLdMbhlb6wNB0uXk+H
ClX9EKCDdnZdR0VGijmieL9P9B0kiBoOPlozIVT5RWPU+kR6xihCaWDSCUcJSUfPWnptv/x6I2eN
A/NKYioZP9dFHCYnnxkicdLRlGy60nmp0lZnILS0ekRWxke03fXKkoZDh8xOnB0M5XI76Ml2TrkJ
yia1oiaR7EgPDbur27+2cXULGKJ+Fjp5wF1S+q8s/foGRjyKYpPael2rSe1qKx5Osa9Pm3DuSM/w
Wzfoyrg660OR7KtKayEZko2Y9Z65ZW6dnhqApPtf3ry/NMX/vB8mwQOLtkn4Prk/n+6H0+gFBpPM
CrymUPe5TFrsM30Nh9vHAzclVvZc6zO8nr4Z3v996WXm8OlNctFwYUMn+s4FYbP8tl+eBYaAIvLQ
Vgf9yH+A3/UfQL+QOuQlioZruM1Fk29AmWDGG4ZHTWUZMBr57d8/45NFkjdi6anibmec4qNJXiyN
v/yKKmYaNygPL9VgcXJcZB76mP/QhPeIYXI+cB+S1b8v+bnnzSU9B2yzbbrI2zBR/X5JrAph39Wi
o+gGTm+63jPV6S2Gwq8u9OfT5UKuyRnDcQygDMjufv3bSomfwJndLrDTnL4troVqF6Je25a1aW+Y
I9JTaDzzmIIG/YIP/UfrfPkjsTfxjS3e2z8sWSFPNpISQ3MWdtWukLUMPBdUj9dGpEPrzb0sw3Cl
EGK1xvyIAiX/4i7/7Y9fbrTlg5rHuPfpLrcanRp0S11QOeGzHlZvnPWeUwsnT015OXYGUgH3Cyca
isRPrzSfkc6aTe+LgcbnVzpB4qqXfdLh0WmdQ5JEqEkzTz78t++PR442S5nJKARD4qepRA92rIUJ
1QQiw/JB943+69S1FKL2l2j8TwZqPg+u5TI5REnJnPDnY/7l8xAucJUaJA+P0T71tXioDYc+K5n3
mHLkak6boNYnulZGvjG79unff+nPh/T7bkO+lO07bIeCvdD5tEa09ozjz+LynWV+AFe50FXzKvTu
1Yr6vREyDYdOiVjE3VCW3uma/zqmKE9IekXWpzDxRZzcsfYk60y8/Pu3/fkV//7TPn1cHRSDIYz4
abS+jmbpX/t2986j2f/7Mn9ZJrmOIN3OZFhhsV7+/hG7WsEECl4Y0x51JzACEqr+mFtYW6CKo05K
GfLFyCcRcprAbDD6oMP492/487XmJ7BAs3dSlphiWcl/eQmAi3Zp1asFK19XgbCh+YzSqr/4Sz/P
uXjVuAplBVZaZm3LnPzXq0CRyotRH7hKKh6iSdx3efdYsts2qg3+/Qf9ueh77P2+Z7P3EDf3edEn
XsvXa6dvAmuWzX6OxDNQLzgW9FV2GPgceoPkYf/7mn/786ylslsijlAmf3qOPgxeFxZcE9iyv4/Q
nawIDX3vbHEcYuvj39f6y+rLHyiwKjNV1U0O/L/fSwCzswlOvQloWTMWArS0dryK+O0JDnIs03HH
IWFA8Ok9VxHOk1qaXzzNv763DCv5awmeRdr36fvox1DTazC1QePalz5b/AnMUbpFWrxRU/8dGAuc
ISOF3p1UO+pWVDSN9sU9/+uPAIXD+s84gU3o0+5Ov7Wqzbikha+qZ8vSbyfDvJyM7l4a8pHS7pq9
a0ZU+8OO/ZWlqrcvnsOyPn1ev5YIFmzJCNl5q39/DkMBl5ljcxMM7QBXatAu/EyvdpwC46Bzym1r
t8GQ0YRziWtZKfSIGlQYJ95A0A+6juFKOeFgtUW6ghqc7ens6BsOrfrm3z/0z5cThRCyESoSfiSx
Er//Tt0rBdFfusHGZT8kveUdU98DmgE7ch7wg/37an8unWwl7nKMgE9Etvmnu4IOwyXiJWfk5LTD
R5Yld8zr0CRqX5W3f2g+FmP4sm8tMSmmY/ycrf+ycqVpaGQqs+HF1QAHc/k8YyxZT2V7rSLqyiRE
mBU1ExrZAohZZPobx9fHPaatDbxljv70jOkKYEktM/Haud6w70abllNZoE5zKCYQwt40A8/HztFs
0TxsNrKbNgOunzXOvW9RV34Rd/T5WaHbg+zE38KnzVv1eTUeYf0D2qznoOcAhU678G5AmzorD+U3
893yq3X58+r/v9ejo8rJk4Okvvz3v9zDmOTYgXCuGTQ6JPMq1Z2bNgrdL97Az0vychV7CbwmiI1Q
X7F8Sb9cJbcTo0j0Yg4QBiJ5lvH7rJLXzpbQThnpI8/84oKfP00uSDoSzg6KGosDyKf6kMy3mDTJ
DN4xTvln+IVmQALjm9kY34w8g3wLQH2VEvb8xXV/Em5+XROWC1MTM7bi+j6r4+9/KcPKJb3DU0Fe
o06U7EJmZd2HnchWGX24o8kMJ3XSB2/+EbveHW27K9crL0IqIMREzyZzT1QIwID+u4+Sn8VBgTWK
CBwHhdSnTR6DSgdgs5kCn7CaDSgn+yDDCPyUnOTh35f6g9fAtTy0YcsByEf089N088vDziat73Jm
LayBBBE3cxmtIwuNNuEO9PnKLJhhamzc2XgjPxhdwdSuOflB4a1sRgO5t8rH5P3fv+kvrwMaJlpd
bBfUWcanp9LXdsy1MhWkrdttsasgd61bGThifjOt6TntsYFHSR5v/33dP7ZqoRtskpwECVtA3+N8
Wgzp2bCew5MH2Zv9yPHBR1jaaBESV1Im6DvS+WIs++rkkhi9xT3biFVd1N3Hv3+Ga/PW/f5WUijg
5aSVqrNgfn4kfY6PO+q1ISB/z/pwZPiSDcnViKd2F4ruezb27j15BQ5BwIYf3TZMvvd5Pm8K049v
NK85ZIsTuB+yaq8aiKQ2mu0S8j8WFDyBDU7NuboRWhNfSRT+ZMvMxsEHoRhUel6+OGCK9hXst9dO
zuYutCt/hxkJSWtT1lvGz+26hUyFLaQg3mQoztVY7uoasLU5gTNyx9I8KDt9LzUhjgatsLe2M9Rt
V1T8yN5eXD/VtjTNx3q01O2U49j28OnsQWU655oRzSoZ8uqqaLHPx34hAqBY6YZiNA830Tiqyzyr
7TMca7oiLraVkxqN7CETVerspACa+8XH+Je3gidB+cSZh5bfH4uENuE/d3paxFFp3TuR/cBNfa+E
fO3bjMQOpAzO3O5rYQXRpH3REvlzg2FXRlyK2IUvlEy03xcoklnQs5P9SuBR73x4qNseTCMs9wUY
I7hy6otifOEOfnr1uB50QWwsOviozycceO2lF7v5ABIiCh97A3RtkQiH+CQ9/JYMppsgo64JSM81
desCtX3CqJzex3kjTpGo3B9DOvAipko7dQXitBUQZ7znDYR5xi7Lapbpk7rVJ59M57JGaQ7P+lZ3
Wn0nrcpACo27/d+f05+rCbHODqI9kAhwpT9HJubONPnNOPI1NehLhWyS68ZPvCtPKt4dNw4PiJyi
ZbbKDPffl6YQWB7Q798y+wpWRTxV/B//62n8ZXmNjbCLwEF0QRinZYLgB9WF4XjFwaw8nIRS4qAF
cw/4ZIiUYKyYOMXiRSquQqcoP5SXJE9RCX19VElyKFsHJ3LoED47I204pbKanj03JhZIDj9g4Rvn
NPbaE6lc+dkbDU5OdVg69mqIGVN1PXEvWy2Zqmt0bS+lYZx1kRt7Unrsk/SqJbimeJj94s0qkZNB
8akOFpkHT40oxOtU+XItq2qRPVroPsJGYJUy62uo+mJNxeLfgliR59E2Ww91a884j5GdhZY9b/ax
l5r3lS4q0kM0Bsbst3tm6biQO93YpSFJqrnqxcoqZT0QFTC1z3FRjQ/0bWDl2pnZBOFUoQeoU8CG
PnxvP5DWksJbEE90kbR5e0WSOP8/IqzqFKJhhSPYDvOblvXaG3W2cd+OlvPmqLqv4ftl7NpGi6Uj
7Qz5onI/3cwIghij9fkW9dAMh0VLcHd50w127Go9EPmJnMUU9MlTomBjwiffYrM3GMRZCGejlefM
TiCZ/1mbti7rcxPRTd5mMLJhr6XqEl0vSQ2xTkB2KlGgrUMNQPBuCjvuhTu29wU2ImIhI12+ID2C
XF0XRDgZluafjcSQlzCLoJ40SfnqWXV8cuKYiN4qEhs/csFQQbBAXyGW5BwwdykupbJ4oZZxiD5o
cN/Ewkn3zFTFognpg8nCvzhlabo3kzr70KOhv54m8L9T5hOdY4yQiQqVEqVnJjuRJiMzhDlF0QrJ
oNWhEqaTlQaxNBib61q/IqE9BtHiE/VgtZ52xLXqfFfdJCGSu3qE1JETbxR4RPj6O+xpHhZ9s6mR
o4S1dZgaDsXbyl1c97glMmp3IgDIMAJFsdd95QdpFjOlTYFZwZmx8KHXyc72kh4xnpsc4zTy9nmD
0k3XTKIek8HHEhSN+XScxRTdCJeiZXakf5FZcFrmNLkzmJhe1I4sd51s9McGg94pcaWDnHECA9To
BhEoSdkfVZPVmxru5mOW+sNWNZ54hSNe72dse/XanrN4rTJACgkkYrbXcroMtUGtTZOIrZVe+OZx
xFGyRvcUGARSbGblanxkCOtxvsijXQn/cRrwzQGlULeNRn2BVsSrL8kCD7fVQDbcMAnuSGecuzIi
zIlW3WXoToGq2/FYZYY4V1VDxl7kGRvX7wh0ARnSrRpZeS4kV0c7dtNYnx03be74TF560TD091CW
apwpdl1jioPfZSSKeYm2n50u2cyYm+8JpBKBikL/WRmpulWkZnyTOQ+TRBdvK1k0bzP6y5e9LrtN
mWfeGbaJeylEOFw2/SzeTXaBb8Q28OjCIn2WTmbufj7Tsc3cIFeLhidRyNw4qlUnQ/qx2osuA/Ja
NBz9JtJOLnFqMa1ikmrcG0wIbifG+nuD6PQ1iWb1yZPRdKVlAEGsFmtnYarbSlnJKVRptR1o7G9N
wjUCzYQFy0jexXyGjRSJm33MivRtdJVPYhMJRWtdQ/mTu86NW7RsRrLxAxPDwHXCEfW6jEh6Jp8i
BtRgztp81VWzdUk0RYrwgPCgaJVmjl8hts5IHXV669JNnKFdufn4UGp1QP7rfJeg2juLlPeXSzT0
TQe5csmwRCfUNCAWfu6CHWT8+DjAQ+NAkpjVCDUWhXAu+GcRdskXs2/SEzoB9wMJY7nuatJqLCGT
XYF4CE4rlo0V8hU9Wo/ciOdKt/mNhhrKM/iYPWlNw7HO0SPEXnQ1+F6zRXVeH23aiecky70bjcSL
TQmw+7ZHJP06N23y5E72dFP68V05Vtp3dxY2aw+qGnpoxtmadDhW6VAicZn7a4GP1AD4aPQTZCBc
zr1sMa0riCXiSqZpY6CtLL1bminyOBeZuXWRGrM7Mxx7QN+EvV/p/ohBkoQwtS8xkt2g/lZEyXV+
v+EOjw5HRKM0NnRpU4XcU2qrsUaWvUNMJbZxpiKmgYx31TqrB0g/syG32D/LG/Lf0Fh7tVutm7R5
yJU+rokJc68qnPDfU0NTT4uCmUu3w7gdDBU+WRr6QFxsqJ/HdqieU7rjArm85iLsUs60bf0mi1dj
3PmnTugfc18tNLtu22UOhntCA2GNhc4l8tb0aRFM75JQpKgbgBys2WVGyPL+8CoyLXvL9CK5r6SK
tkVpOZC4FFaZranMFrtxo80vmj2U9cbOiBxY868v9k40s97oOehkK79hPlr9mEuLnGxHlBh5/X58
cJU1XeMqoSsSYUUmYqoqgJNJ62jEaQ0KqOxPg8tMJpO7ucAWilDYfht9szsPkHMfwtCX81aBVTmH
lW191/XkHemLuIo6p/nQZE6d2GOlfFBQpFByLhwRaSiqmkx64mGeTaaHlaOfpUyzg58SCqSmDscz
bBi0tBne0jTNX8gD8NfD0MBHKFukNKCLmyq607PhxHmnRQyqGejdoxOcgxvXGcqVP9T+hab4WIdI
tw50HT0rcGEJVzsD6/wFmQXUoI4qifzKTUInxm4TM4F8VSkm00fRzi9TYsf6lk0aLEQPomrt2wMP
iODhPQ0l/zgp8wg2yt4XqkEw5HLm2TWzcw3Wl8Qo4YD6W5HtyS4HFIcl2LYatnZRMkfgnoCOIiAO
VtTPKsjvI9hdsXQOFfqbeaVI59gbJHt4/MZLypX2moU0J3FCPBbOUsc0uX9yLTTWejrcjEaUbNm6
05Pq5pPeF9EGmCDYLqppp9DbnegpqVG8kScU53ucvgULKFodjnntqjfFUxmSnRozm+o1YbAhmz9C
3qm945TzSpJoEXhSBIXWu1syp6DihCXm72p8dtNe2+et4iePkgs6WfzIHcrei5ocITTIYpt5ZEkR
rkd17fmHzBlU4BVme9WRKHDol6ZRU8fqyXWL5NjmEStQQ+SJrmO2Rvu87aqiwvYBvcgYwfMiTsUh
qioEhMrLDrpl7UiWICq8HatAVvtEKqI/ovSej5kUhWg+Z6g4cSPILGgn67pz4fFltWHfeKEB2cdR
+KfVBOe1S+LyKiPq5XoJmS+2TSPj8wR/5+QwMLxpSMHbzRj7zvOUXrG3IdXjzlDBgo3dFQ3l6Oj6
bZAIxF4+C92No3pmqcCTLtI2qW9HC8qPZxTfyJ6cCNyigbVxe9e7UMt/oTddGq1tgEzkf5G9FOM5
Q5DZekGrsgY5GLprMdTqGI/KoR8W9Q/8e04DX9cRwEC3dO2N7i0q3giawHLeZeOm4q3FwjJRkUFm
3NV2blMnh+mF2cOUHlvJM4zCOkjC4oz42DhrNu8mqDUMDGa5D1tIkXELVBw+gM0/Pn6zXKy/sDSm
M+79eYMLfTzoY2Y9aGFVX+REk90OkBwOVpfp11Ef1rvB1DnkVMSvuBtDH1WxYWCqWD6N6ULMZgHD
054eXLz3q9SvUtDci+irLux2LQYT5wgAO+dyCccmX7EQ6Fkr0rRhr0FnhvVan5iRkN+OnxY9W5PY
fDz9bKTTGpF0tvXjIQ4iq42y9ej7pJBp1vwdl4kcNwW4Lf49UUj8ilZ37vUUxhavjtdUrynW37tB
y+ShgwRQbaNw9MCSIEC9aSXn3HWq4zuAwzSeh8pUW4iCsDKjKWSZIpinuO/zVLvILXuhoM8uBUBl
aPSM6GGir9n0Ns7t0OHR64WtbluZOm9qKH5oae3YWzpZaNWUDpYm0QVMPjTwLaqUSea70XY8BK8K
ZvhspVsjK9PbJAcdaNSG/wL0qXzCs48EecFTVcueb5ANttaJMUpWMwYVl6SVytsMZFPtMPxxCGtl
dKW7JVI4d072bWWWdHIdGQBfrsG++OtycIhN63TkuK3jAdwACzUwC5q6eQpIpCJ8laTKcN1iRQ/G
xBJ70q26wJ1y+W3i9drokXC2oaeJLQjxbtH8TXiqayzM104RtTvOCBJdIGKazm6MIJsLGIp4ZvQ3
gnncjdt4xjFMO8lkDBmwpM8NX6PDzD+jG08TlEp1Ljbt6FDUWSpG5wlqR8+iZpubPJxqdI+1P50Z
7RmPs9Q+RJlGj8NoJe9Dp+vbuY+Kb71WIO8g7zFb2115O+Z9dGydKr4gZI613QaLAOLLWjn2CFt+
LH3jzifBUK3l7MBFWX5S69LoGcCEd40hV8S9lhiGkBs32lBfDJ4JE5aaruvASdcyqwNQu/1Rp3u9
U44fHo3ZyncEa8qNget1QwIRH+uiMzWjcjz1LFYrJRvOL1rrX9Kgn8kxmht0IjRd905HUtaKikEw
D6nCjv21jrp70udhCrmVgWc8K+I6yMZ819ASuQTA5q0aC9Id5ordbDWUt5HVcxcx7B9G1WOytyYX
Y741PNlmBjpVakj7wzbn/S2xLtFhI6Wp8NnvGnMzxPdkJcVHQosrfaViCsYw9xjfSPbT1eA1VHdL
0lOe3kdjEh5CQyc0i5YEHYjpjuxBl3CECO+bB59i6SH3h9Ayhm1pFXg68FVsM50liXjuAr6GPss1
N63a0RkAq0ztHqSkfYagLZeEGRr27FFpa4iLJuvOsHAAvHLsGrB+fIuY1OMNCV98E0vAlBOtt0Kw
dx3ZUNXojNj4TXJ3TQj5hS8QnLldO27nMPUDS6sO80xykWZrz7AtDqigv5fGIs21l0PcWJkbYqvd
QM0LC84eINl3OG76PgamVM/3A5H2QBjSed0tKFly8IJUZ3jFWWXdDhnMtTGqaYNMM1+snxJALrRt
pWOxlEioY0YVqzhN5K5W2XjhpTQYTRsXTbggbskwAHNolRtdZBmZ2q64NCy8kRBuL6wyS4Is4VVw
YmMKvElndJKoyzLFoTZH+W0IyY58X4hxSnbUu2oHVuSBh/DWRekjN+pxcrL9aDe7ScEc7fEF1ezI
djA0kaw3Cc5JAguV5VOizJPvrHqBjNmzNXVt5Wl7NEyKoJkwHcFKOa5q28H7lWCIvfbmRt3YSQ1N
WGJKuUWcXK/qKDXPHif674nvOmvdKJ9mZpTVys4wD7Z4W7Y+0ZvBZHfROiQrdpcq3/7G9+QTSc6y
jwnPPLmOBS9J0iyC1WjuSgKx0e2BssldLKXGYD0NhnXvzVhjx6KQZwdR3wqV11NSmAmC2ylD72XM
p7Kp80DyNPdJZRprsrY5mRFuTiVkjevciDjPJ5b/arbzQ95GHCU5tbOLkrMMNfqD5kS2rv3kwVRa
jxgzHtYQYD/6EHxGg/txtDlc0940rx1zMAn98vVLKILejeX13jkhfXZjyD7do40rzpFmHOB0eOel
6x2vShIY2R/yhFz2qWL7zpxzF3fmJVHa+VmvsRZ3NSEro/XsRQbWupLaIYTXdumqpuDjGv+HvfPc
cSNL0/StFOZ/COENsLPA0gVN+kypSvUnIJMV3vu4+nlOljSdDLLJUS8WmAWmga5ulaQ85LGfeY25
NREI+cPCA2+rtPWyo1F+1xEagO5rhq9OLxVPeYSwZGuSuniTMu0pM9M/MDWqZcZgFRuzLeutrqrp
nVRG3q1w7ftq5VD/AFbmjow6Mh5NJPQj6iaIUkm8FIFshh8bijyA7e3BU78Zk8UDlSgmWH0SZO2u
k3UCYh8dyUJugy8WNZEDLsLRo8UaHPy+zA6ZrI3CCNKqXx1zDBguiGhLjE2zzaLRv7csfMkM3uTv
qEpJz0WlxX95RTreDBgAfK5TLX5qGrmDIytT0bJKGvZjD5ceAaGWhn+troSM0hrtEjZP7hsrrSpt
jqJa/eGr9fiiIJPuDtC+PtaTnj+yutCemzYMtp5H4ONHcnRjVX6yplVfHNCO9ZI1+Q4ED2U0DzC+
fPLzRl9i2oxEjBbk00pl6NsmG0I6aFW7i8o3+D6ybFONfOYI3QJYYId5fWziMtONwUOL//QzlOJq
W4UGUY0dI1q8LiPVpwVBfjQ8hUqGyADSihTaY6UyvvhTSKECRKWzxheVZWoJGaIDugvg7m0r+epU
vFOT1eOSMBiG81KagbEstbRYTkmqf8pGzf9dIrSx8tFZ23GZQ3FSNWllY3+LIs3AM4FXp7MsYHN9
CjEmcxtr8J+545+o6C1lnZSYlj+hyXNM9ZFAzdiUZukOyOoAOLYhGPCA2Xa1sJRAXioK26R1kj+b
lOJDjbYKTQgJp0xQZXKARWKRaotpavU1Ze1tQLNhOYRZtpJspKnBOCJ0FzefQgS0Obrtt6qlWFMl
fb3KA1OIk+VPRV5SEfRg8ZVBaOwR/isWsBXRT1ckhOwwk19PA2LgSRc3u4Aq9srgkX2VPZ7oxkjV
jT4Zxus4oNdltDC7WgI9eOAEJr3THdAJKm4EAHRHvV5CMlc1VtXU5fVC71IENZ0swWmjHfZQfrSc
qaPSRwm2fm5lNDgoX3W3hc9FoSKd9xK3rbOWWw39m87IAqJcn8SotiGrmDV6U4BWTTbTYD+WlLVu
3hLuMcj6j36QKTeahkQvWkTNQh7zYGtHicGz29uHsDb3aFQkaASpmxHDeX9Rgm131VxtnxVdSd1O
x+2cYnUiIe+XR67W4WSv9y1ELA19UVga1pcMHcQ/KqWpP1FXQ8+qD/GnWUVqkB/SbkCpjC7BAbUA
bYe9IeY1RDw3mFAWaFLFkYscKAK6WYT62Rh8utxweXNROW63CAgZX8G0MJkBZ3TcL+tpRsWBrJZr
RY90TBJL3jvF+ZjF1KST4j5D4f/Z4FN9pOfyyvNE0KKmsgVUT0uML6YIp3vfNl2rJNVP5OQjxNl8
X+eTv4jDLKC+ZjhXPvOZDrzBPQ+QRDNp+NLwPv7MOhUmr9di0Jt5pKMLjphwMGhoUepFvEx0gFq1
uHGwwvoeaBykmqbBIUpr/bawUSGbVECfBEfXlEtO+2aGBRJbwTWDdFBRZq1HDc9Yf7J8VNgoedcg
TehHPSIMzHNUBpDNUExZQOBMrgGS1JOOGR49CGzgNQYMDxjE8XRYxsSObkKI/rmS7B0cUxEhxnML
KpL1UkTaF+DpH0fwxEu7ijpSBAJ1g4bBoint7CGZigTUovGF0kN8SyPSvutDPd9Z5aitJoluWzqp
OfBZWTSpKoVmAkSuFc2OvyrAtwsq2haRWsE1IPvqN68q77wM7W0F26Ys6B03haK0NGjP3zio46Bg
AGvAQkRjb2Jwy7sw5aTdpvlCOQaxmm7qPlexMq0qD7cIKaq1FXiihGgm/WxDPYBKGinmt4mzs+Do
5Qd98sfXy4fiBHmHzg7gYfqPYBvMU+SuM+YgRnvgooVkjKu+Gl1HRomTSnzsJrlJNag0reCltaWQ
6wZhSsXEciAycCa8/ElOgA0AK1QV9RbNpIVj2bOlhRApY+Er5+tm1MxH0/NtehVa//A2yi9xnf7v
7HSOBK3OGyH+N1T/BSX0z8V//0/VfgUx+Zo1YTPuvv/7v/Gnf9CcTOcDrIQ3/C1sHIVz9580J0v+
IEMYsMEGahokAvFbP2hOivrB5MoywCZgacVVwQ/8h46VrgAiALviCOw9eNNf0LFSxf33/k4H/wTY
GQ9FFeS5dYKxl2wUXnBGsVZZr6SPBnUokzjA3/Z49AgphD7dcW9TjLElf6+MZYt1MzTIZSFN8UtY
F91eDukk+RXiGbiwgC8ZSuUeP4WiXSmWY+yr3AvvTCmyntTezp47u7bzjWqiM/P/amPed69V0+Iy
efulqH/btNn3LwTR2f862nX/+/iX9d+/9l9zQXM7+sX6bdUf21dBkavbpPm5HOJP/ld/88feeblM
uOM2v7AJ+Rx+++XNO3Pxpfrafj/akvzdn1tS+QAYUKy1AKEYAMP/c0uaygcHzh3PPCheiDQ6l8zP
LWl9EOw6NPbpVJmi1v+PLWl+AH6qqQ5dQQNgu2H+0pZkbx9tSRv7TTDdYMfBieF3xCd/j5BsVWrN
RVSNhIqp9RwObU171R7zpZAr+6oVDvoDRhd7m15W0H7ABQmdg94JnxTHUw9w5yFDh37xFMZ9DzQC
f5Fq8hsVgwBMsYW34/Q1Vr3E9SaUHBaQ7+y7d/P+8Pfp+Y136SFHjb/+9397Y5O9P1TQGRXAZQJD
ajArb2/GO1yKJGM1MeZGvwpaY/xCl1B9jk1jpKbjoEUVIIz2ScFUfJEjgYqKQqqukCrbjHIP4hFc
rr7DkskJsdawlZzcViFPaCUKxH5AZY+I6s5S7PGhbbT+D61SRgOfZk16oLE3bZBMntamlVStMK3P
/pioEMn3fpLR95Ez4BZmFAU3nprRKRpFL6WnehouGsGjrslprqF05pgnMRW8aHARmQ8dvOXxYiot
8XmCvthKVwyPbCawFu0gS6AtoYRdnvY5slYMBUfGAvZGX1J2xL56N+sh3vAKDEWky6wRQkBWyPta
8oBTObTmrNqzXL/NHv/n1jmh+bKml64dvw2TY917hb/x87JBdhHmI2xTB6NEAnhulB80X1P7AAbO
gKVqGsBxNYWD/vOyQS3fAU3moCoq2L6CVPHz/bM/KPw0QhfhgCbuqF+5bE7CN9skBLdhhQIiA5Y9
P6pT2tGKxmhkleO2szJkAGE0etdjkX/LnearHdqPbTkq20CNi33dIU8y6lRZ3s3YmQvjBAVJiCCi
AB0tQ520YE5jQWWXGKC39VWryfKhtbu9naWvdRS9DFINZV2iEEg/ZZFnOc7yiIdcGf/k6DC+xSwL
cKIF43p2SrkJCqUGGrxKdeLUFYUowBI4t9wXqREguIzsRbrQJGXitjItGUUau8R3darjftMnGRLN
aR8iXUCnvaB8EgUrs2zxtMJ+ClxqUeSr/zl282PHioiWCE+IbcMwFaz2d6sqgosfQcPdlxSW/scs
bF6///bc4ENRY57NSfrtHnT5GGb+b7s6wVK7fh+inv3xP7n5xgdYChwzeAoQZaiJ/zy0WEZ+4DaH
sk/0aXBkOek/zqwqHC5Au+PahMwYkQWb6MeZleQPQHyRvRaMAHIkoLbWL51axn8XIpBrYffKfuVh
EYwjS5+FCFDr8UkKTf9z2dF5ANNgPCl1dFfU0wHh5tcybdwSV78F+uTNRhkQStYxsEB/ZBFGSr+u
smtEtOMD9OMD8f7wBlmQ+ubJV181Okb2nf8ZnwVczHy6q2//iHHnWxFe24u0lX9/t77Xbw3m0NGx
pSQLQM0DByzCrqMHr9bUTBqlUEMIRjoYSrVO0776RIOvXKAsnayrctCXWUl9DC+tTybuXpc/wDH8
Fho5VFkD6Cm2JQbX1gmeOcAUCfdI+2nCAcyBZheU2rhBHX9hSjtEAYxFFmp3oypPu18dGElUCJpc
hjbUvznluaoJhFTEcJ6w+VJWmhXD8CPCR9G8e8ZcD7aZ+WwoxRYTtM+XR0ZS4mjrsYVZYI26DcIK
hLqwu44nPep0I0ux5XqExbLQ+O/t7Z+7HXJyS9/tFois3zlrGghbsu+duQtdc1cdzJ11J62Dlb2C
ZrKWluLfiz9XbMGmbpvFQ7XFVm4LHm6nPjQLDJz5g9+65bcHc5Vt5c/VwVmjkMdvR1/7z+NDcpjc
4XF4Mm79HabAd9Odf+N8HB77B3r9QC923UJa0sBe0t5fV+tvD/zQb98a/u+wBHq20Jbh6tFYtUv8
Uzfe0lv2/D98qbfmulrJruzma9ntNtUm/SvaletmhUfW1tnS+nexl/SxIFtM3+U7ZTc+DffDvXRI
D+baulFvpa3sjvt+Wa7xO+KnKbvq7efba2MnbTAN204P+p22Ez8Jnf3lX9sDbhMLNDBW4mM4q3Jb
HuptsnxOF4Bhl9h0ud7S2GHX7jov9bZfZFf2sHC0fXeV/FhPhBIdGEqGyMaP1zPEi9wrDSl53Kzu
X8ADH8pl7vqP3Vf60lpDa2XhoCuKEeVh2vrraRGulYWySDbTNlznLn90DZJh8+re7ccF3s/LZ8qd
W4Lu5bjgX6yjdbzCeGKZMOWZ+C+szGW/eAwQGIKWusg+Og/4o6BVKq36rbTyN9lS/N3t9vLG1WdZ
ldi3msHbTN0PqDx3+vH3LHREorxOSx9BY9PEMnp7P3RltHPwNuzDgEr+GI0LfAG+NnJT3vz9jzTY
4wQT7N5+VY/958zvardMQyHOlLfrMBu7pYJC2tLuQLCDzixl2tIozGM+sH/7B85t3wK18JcW8mQL
mcxzUUHAQ0Ep0w+N0t97WSTvPRZq7/j1j39kuUn3xHsDX//8d29/rhxa+8oOMI6vsbcd8Bag0o7l
/ub1Op4ZJNiGaAwBvVG/2dOWvtGz4ClqghsbfdymeVY8Y2WF8R3xz61qTPRg7M1U7jrfWU91uVSn
fSR/9wPtJtP7FyvKvuS584i5z16JnUObNr+3FDW9GgZm9jXU+891k25zIBbGWG3Cqr1zctMNlU+0
Se01tdsH3VbcsgAN5k0BGmbhymuHmwEt/UgP13TJ13lwb8QttNli7fn6OrfMZWN228Rz1o6MEpPe
HCIjvNfoRCAG9QTf4BnXnj1V+F+MW8WmshH1oSTA1HHhzlKuNLJbapJp8CjHPDVNZAHepfnfy3/J
jUXg2riK8TA2qKQDwbwyuKhnvk+yqXaSIOhw5XRiEQpYx8tme70xDo3iwQzNBprDPYKpE00nHXHV
tVE3zRPCb2tkh60rG2a2X0RYxtunCMN5MgZ9fpJw27TroTem+6hWX+PUEbItJRbKvnrv+bWBmqhG
aOwUIVZ2teJePsdvnYF/fG1bBmPpKFRiOMb0NQgQj792geaun7WG/IJqs7oddf8pSu34QN9ZRktP
SjbkTHQmjfwW/bpdOIXtbSxAPUqKCI8JbFrPvuj6lK38ZoITPBTfcK6CHWFV0RX+7vE8/fykpDSI
oyiiGnL8STM8fPKE+OGlVcLPUJeNZSrLFGA064As5+c2RmkoLLNVMiXGlb2B+dn7zYHeAWBmEkey
ThpWFMbF77+rBVC2RO+lafPHhHZnAkh0XYBT3qxChFLdQIjftCrEzzSe6rs0BEEqpN1GbIMOPsQp
wM6tc0O5aetXQXPodOUPe8z6x6ZXK7eq4hq/X35p5qCBADONywy8oNvI40dgUMkdjSgkgHX67KhG
ftSbOzK28Sby944VdM+5AoEiKPwBh9kRRNRgYErUZ91+yuieT9jSPkEPu8Pjz1j5o/bxbf/8Uv3+
fNH9qC5/X7xmz031+tpQJD0uhf63rIwKGus/r1GIcuiX73n9Pv8Rf+NHumM4H3SVEpWgm6OSYYtC
xI8aBb+FpIJNMIkJPA4iOuHBzxqF9oEKvfDNY3vDuhft0J81Cu0DckcgcXlXNJG+/VK283aT/ePI
UzuhqvpGcqO4BQ1euAq+38xZ5NT4iOvSMjKUG1BrfkM+44frKTa8dk1rTK/WkqdKEwhODvyypokp
LQPdqJpFCkBkHzRj/Zcx4YW2xAa1f0XLHMOGKtfhoaHiDI5dU/rvQqN7UdWF+TE3sui2wttV+/v2
+qXd91/rHv1/XKRn9/zzrfgSvP62+BIgjHe0G8Wa/0y+VVFop8tO90dxjjpGNnk0m020+JCuYJ9y
rf3Mvq0PKhUCU+jfib8jfuvHblTlD/wYsnnLoi0o4sBfyb2PU28k+UhyERSg3K+rb5v/eDMaVQ8C
XDEKF1hwvjQ0VC0x3Cs27yblTG4rou73W/7vURD447XDa2XuYeIbbatrg1a48DuXXeM51KDQ7Mbi
oF8MOMCvmgxv8ctjnv1m4HVlUWqBVjp7Wac8QGVVNws31dV8PVaYTEtyUa8uj3JymsVXo6KC1QZi
HSTts2ex9fOmBj5TuLmSIkmth6hXr+RAmMfVmNUvx2AyERil2XMzYu08Ai6Ukj1BHIj0SimNXSmX
g2A/pF9DrJPwYczyVnuOzEZrXbWwcIhAD1m6AbEiqQ8tTHbQKCEuBE+jHwYvl7+NuBpnC0X4ZVOJ
IBah8aNzCb6/mxA7dUDTdLlbT5L+IKkqykzEz6CX7ED92Jqttxh7hHRrvIQ3USV3W10vog3mDvRe
pNLqr0zvSSlVJsAkLOPlR3Ga8sTs5TcdHKDo+UAzkGxzryvq8DkcgKdPcj5+GiGKPEhoowAS7szF
YAOnleRBvyIKd7qTeEYUpC8ITEks5+VUI9c93D6szLW8pP89NOv0trPCa0JL4pscnRHqX/SPFZn/
oWc2l0eTQjmT/d6HTgN/cWn3ebKXhR8AOPXqyqyeHEch1ImACLcLA+lC9/P9KutGoyq1DERHx4zz
gIjl8DtCZTiW2OjKysMgfVf8qot+9UAyqkVSTiRHxEu153jUEemtkX3ju77g9ULSGRKYGHW6vbyH
T+aR1hRZMdkLt6YQ8zsexlehhCiNUrohMnsIdDfxOrHH6NAk5bVc82RjvA1FwQ6tNMIDTczzu7DU
K5xYH+q+dKWmhtiP1FwtWdX95e8jyn5H+4JBWCeKo1DzDf5xPEiUqShbREUBD87BPgKB363aDN19
isr5bdIa1q/e1VD/uQQYiqQEsMLsCgh5rcCODqXgSjyoWngz6RFi5MA+00H6Bj2sWFz+gmdmEcgy
Q/L+0AISMdnRLHLtTRlUOABjpr9M8cZZZdjy/eru42uROWh8fPrdHOXjUaw2U1MT3qerIO4KEKyt
1wpKfP/KKIwksjla7+osg7bChhnFesftq9Jbj1H/dVCs+sogJ10u+uiEBoiPkq5SA5oj9zx8cEt2
Jd9F1yYA+j1ISGWCwTwpn1KQtDeg3+NtqU5YKSdtCBcHiYIccu+Ve+Tcylk0hLHAQgCGzP14TtWs
SwzVY+Vg4xQYOTnaBrtn78qGFO3G+QlAS4StocgoH7GGx8NAuDftWuHrIoFLP6oBwh4F3VpFKH9M
u5egJDcPNW2hIVHmh+XOK5Q/BzgNSGQZmHgqiJM5MF9+fddaXGTMP5AbWQRo73etbsBwRrmrcEet
fRHh+kYvx2tx07kJpjTNJc2u5SkUd8O7C0YzAAjLFYOAPM9cSRK0Xx2zzctf5dz8gg2x6VeSXpPo
HI9S13acg6suXK/K5G0bF+FLzK22H2orunI5ix81u8zEQy6rlFtU7S01e/+FRhaja6u2cLu8kVCt
x4jclo1sVUCwxaAZpywkdcZ1JeMOcflLnh4aWlYK9yf1C2IbFA2Pv6Vn+h4uR3nhmn3dfY5aI9tn
UBPcosVrRiMcO7RWn7/CoDJucQNL9omueUvTM8IrO0cs2tEcAALTLBpdMgEW0f3sg0igyPImh6mj
+uVfsoxpdTF2ydprPPoPKBFdOaQnj73IEUhs+frcSyAKj7937dl+nWJ669I0i+IlwkQ+4HS27x0m
ZP02TnP4/imAyo+XJ/xk7zIuZTWeLRsnOGVe0GsMs6+ivqUcTXp0a1qcWkrVxpXXcV4I55ViGAJv
UiyhIX6i/4VSMX4FI1ZNrdR8LG17BAmTtFuvSqXDWJRAX1Fz2AVpELiNZCV3Vg3tGRsfe2m26fSZ
iRt3up0axTIxehM1rz4aUCfKnRer1f9I9WR8jCWeQZIVPCjUmkWKyxJiNvToAa7PXoPlsMjkoV1J
GKw8apberWHa4VaddPIha6fg4EFlXcH9CddaowXLAM1kFwXxahNDCHXTZIjvinQyV+PEvfbLy4CM
IPAZ0kX+Mw9eJYcsRIV6hAPbiDaRTIheRt3ny4OciMOxCkKskHAL8KxCSnS8yXoV57kxHjK38pJv
fhHeD6ZJfyQMgQYpHW5+XfYQaBKqcNMaEK+x6D3TDVp/o2oxdmIZZMehwqygoOtw+aOd3Djik5En
091Dc5g87fiTYbfXIQ4ysf3Vod1NSlWh0qc5FLYjZdkpPidA5RZAx8++cvBOrtXZyLM5MUqHejrC
ym6KdS/0OoN2V4wySRq2+b+yyChGEiFiUQJr9/hL+t2k9nKLtphdwWbKzDIAphxcLcPyU2YXl8ZG
QmyNU0dQOpvKWCs0hD/Eia5bxdVQGlxpk/fp8nqduTaQ6uW5p9wrgt7ZdSVLRhnKsA7cSrHL1QQR
H4PoXrmyNud2BYUIAEtgGEgWZmtjapUPKzJibQguIOLiSBnQgViNUOZv4U2a+95vOvSDJFSqf/0L
AncQIGLOJcjI47VCNjVsk2ygbp3p4Scdd/SVVPXG9vIoZx4ZASgGA0QFiQr1LGaaam9EuCVMXRX3
rwOi9T28Tmw+ch9ycOXrwZfL452ZUBaMagsDgh6Yq22qQw/HyYxSV+pqyTW0FovxztfcKMeZtWkp
26udxTuTjdWV+RSB+2xX6oTbXD3osAn8xPF8OomddD2yP+40ptXKwB96ObVTtYIlEj2bLOrat7Jq
BZ+2XORFcc3o9Mx+PRp+dvRaNlEhtXXiSiV+aWmOfMlgVsOV6OXMcoqaNvBuVo0OyGyUGEJg4dUG
o4Dj2Q5EntvIh/2pIKq1gVfdXLlQTieVy5ILBSAK8RI+y8eTOkkDUXUeJG7O762yKP8D3KqB72Zk
Lp0Wph1wHP1eglmGcWVn7351M1Gc52yCmOeywd/heHRUIeQuN+XCjcr4njvaWemtJd2XLVzvBA3b
JZtMvkOQ4MqtcIL0FVrhlL1ESMFLBhjpeGBFK3s/9L0cjcawqW/jtELMDKaRJR0GlCZfVZaXDKSS
yvpxaIP6ljTAqJdIYEHUSP3B+X1IJnvZWgPXhgk58XNVK521osYlfekjRIkWClZr1aKJbBzG5Lah
7GlNY/MkxxK2WEXbkraovgcxdeg7xP4R0qw/ZUbT7iD35X+2voW2WGEXRYFeV23fk+fgdYcryGd8
h2xgB3kf/BnDMn+9vCSn25xmOoEzxSKSPYi1xzODOsoQeV1UuJYjyZ9rXmyorFX++fIop7EqaAaN
ZEojkBOWLcej4IymIfqN8YJEgcPzhxuld3DE1LIXG0zjApqhc+X2OC0wAvMSKQnjaYJ+MXsJSjms
AxuZOBd12Rahqd7bjzIAZ84HHT7VQ8E67hH4SAv08qoKd+naQiDxV7+3+BA83wQpIkeZbXi8X/NY
rT0ohY6IzhOkevZtOdk7wG4TcHjLVw6yZ0/fLw977svzALLRBamO0GFWrjBNL/DRKEjdJrQAJBS5
DOUbRy+d9vFq6JsGsnVk/4nIbw21tc42URlN7uUPcXrVqIj3OjIAYF5i2hrHa+5IQZXKwcTLkWnF
S6JZoSC7NmurL3FK8wPE+SjeR4cowA1cj2PryvjnJ+HdB5jtAGzS0q70kF1pUVJ/LJspehzg3K/D
rpdWkWEUByT5rA2I/QQueI5lHVCGK9vw9HgdT8LseHnNKCO7piH9ErZf0N62nwx9qq+80ecGARZN
C5/qHv87u9SbmvJ2p8pil2nBQ93pyICrqXYl8jg/CtDjtxVlYx2vZ+DHfVvAeKBarsurRknVB8SL
7Csn5rQoZKu0BiixoZapgNicbRutc+pKt0vCqCil36/3wfNQj82KLoJ02xghlrXt0D0gVWXcZrjj
EdoN8autJwhqDpJ5h4pbjCkqckTIg0VX3M/PzcH7Dzebg9aEDuwoNctpYx+n4pD6KMFjX10+OQYz
eRz5MAVvSG8aycLsZDbTQa+VrcIUZHqRfNS0MruZSmQtIj24kmWfhh+MBHwZzD/dLm7o45G8ovKR
UE1Sd5xCBS5phvCQ5QTrIqz+bKzsWg5wbbjZtSSpvGo8LgwnJ9ja4h6L4o3v7QD/g3BDCfTKRJ4d
jw6PoEIJMoJYzndltrpBPCGEeO7KWKN8xDJRcaU6MFcY3TZUpXPvl6M5phPCMGErzwg9kePxei81
bX9kPOiyaCL1WAvFyMEuHbseXdXru18fDzwOTWPhlEATbXa7ZFktB/1IaykIs2lpmm2wto38C8oV
9cGa0nxzeV++VblnGxPoJQxVbJQg0s6RzJKfq7GXSzFwMRl/0ij+qynspY9GSe5n95IcQuWFOaWE
8U0klXu0UlYWnr2VEm+k3L/J6fWt4jbCOxA4UV5stAQrpspbBYkcXFl6cU3MPyoECVgjChQ5elPH
S9F59B66gg4ivoJI5VB+0LR7WvMFmKDGwZkeAYPLsyPO/smIJu8t+sqC3jS7uNAXV9A+NGNXk6ve
1SxJVKjCeCnX0S0i8ubetyaZ0ol5zT1G7OKTgeHfUF6RoejMUzTcjid0zYfYHfvWWOGMXKIcETRX
XrI3Cv5sGLgvRFLiMAFSncUykoUOWO4FsdvEiMwlNLQ2VhagONw41ravpnCPpMf0JWlCbeUorYwA
zeDsjKSKVyjKIO+SoKR0ecrPXJRAGrm83jiN5E/Hi4ziJFp+UxS7Qldxh9cuEY4cAjVP7GtNzrND
cZMA+DA1Gk6zocqksynu8u3jRg/dTI5IfP0m3SEX+/vlL3VmObmvhE0NPHVKP7N9lKqlrMO+jchV
vBS+U1khoWlHV6buzNUIlYoOBEk94gbzakUtj/qYFohboFYRu3anOM9IC6J35XmTi/DKNQTCmfkT
NAgUKRDzJ0SZXVX01TvyQS1yHR/JWRogwwY/53Fvt9kP1hHAN3i9D39vyfe8zrND8c3oe8DKpvd4
vCtaKU+HUG0iN0i7iVcGjfxp1NSd2Ub6lffzbYfNDgVoTHywkKbH8fJksWolb9vOCSnCK/2LgyjE
0sFzwDUKjNcrjFW3lVzJaCSPAZ46OA8hv5DtNBqIB80OvMcg1PX1SEXsu2b5RrmQBgMCM8ol2YCg
ESpNMY5t9A80nIYPZoxY15h53X2MndLK8FDJqGGH/iosAhwdxGORMtNtN20xv+9ezVY247Ke+E4D
zY6V2RXmYjTa+Mp1eXpBU3MUBl5gc3k05+mBknp4vnfI9ebl1G1yozDXnWG3LrYJuWuaEjo+FNqu
vGCnW4NeI6+z+FY0xuZeNdoYNPBcg9Cl2hJvQuiGCI4A0LGs7uXyKT6TfZD1EMb93d+350H5gDGx
HFhImLRVLrl9a+sbRWvUfZuXGvKjKoITOY7PwJThbaAyuzT96pq3y+lVQn8GBBhNGFg4J9CTjtQO
fl8auhUYo42RJ83aGIz8ykqeiLdwpBW6NKgc4K4FWmIWRbYtSvJAsQMXLV+FEADlrnUVyd5KmryB
Zq2H4B4IETyC82wXeJV/PzrZn75XGHiZd9oCQ5XqoI1T6V5ZA1HWOT6dGle2QLwbb55fs3hTofcC
HUoVayB5OzSGAaAPfr010D9ZjFk23GVq16zTqMPGQ52s7VRgXDRVIR7uNQipyx/n3Oaj6GbzeHK3
k9scnyvDHHq9zM3A9WvT+IyKmbxBKlEFWoyU2eWhTmMRof8D8ILCrSh4zY6wgXKhqTVG7Mpsbyqm
NeKRLZ2rEf+xhZnp2qLx0ZalAHKt1HZu35O7ILSCti+FNnk252qLSOmolbGrRo60HvBFX3CB6tRd
un7bTMWNPkq3uDeki7EYVdcOtOr58pc/M8/kNDbsPl5RQuPZl7f6FhVCRMGIwtF70ejRISk7YsAB
N291eagzlxgEShssIjxoymezp0YLo8Ac3141Va33Ev5Ie5jKSE7ZNhK8RlciUoXN3eVBz5xqbKIQ
j6H/C1VzDhyyzAytvZindESJDMlNBTLYQKvy8ihnEnFhrUjNlDoxDIq5A5aWISU0AY93efjupiGy
78fUljGgtf1locQNRmRF069Q6iKQl6VwZ9ZoyrahjvOn55c0Pm3phtYBevZK8enyhzu3xPA76AzQ
agf5M4vGAs1PTHuYIndKxrvY1subyEbIDXSmfoUdcW6yeStECxo4qDxnHemx0hRmkiICVprRtDBT
XNUsva2DK9N9Go+BoqPDApH+DdU627QEYxLq7BmhmAbzzNMR0tXD+jVS5XvurWuMoHP7VnT6kKQQ
/Mx5bwWnAzkwwBK5ZJDeZqp1YmY4HpDm03ITWH6yQmxZv7Jvzy3am08cuAHE4ecJUpQ4TtkPDiFn
lodoLpr+xnSIbrVOu9Y3fetLz25+kRMI4hFPE6zm47tWdkIl6GWPDSIpzwESe2HV3BGA3niGuu4C
axsZ5Q7rog2OfIjTW09yWYJYru/ssF5lPlX3vrrTveGjVXTby3v3FIsrNFh0ils8PQ7Y19mlYSFx
PxLsRW5C6XMZhzoy+kOhoAAY9iszjY1NH1XF3WSo+Y6v6K9bb+pcC0Fy4DT+tRrCmbxOfJw3tBPB
Mo2A46kqa2KiuOIsRd1YrEOYiYchrb4kbRE/+HX/1EcIAgP/pjEAbHUZm82wRwgBs9KyqTEZoDF2
eYLEgCdrZwhiEGUEIMuzw42l+yCrPRcPRglorKSSs0AkpMR5RVZ3CCDSPQ4c8/dcDbrtOBX/QtDE
olA4gGqiC1TR8Xx0aJ8FcsfyOH1BMq+U+jIHyHUlNjn7JYWEg+A+QU3Rjkfx8ozoVxoZhbYJJBC7
/CTbowIJHVZawrFfYgYhL6JeT+9q7AauzPHbtziZZNJMOqvIBBLtH48/RKkvOXlHlplgPaQHj22H
mnhp7jASQ3faXpfoMxossNk691rGDeSU0T01wZeqxx9B8TaFbK2aWlkgPrXFMnSv2sm+0eNDDSZF
z6JvTVzcWH53A3BxWcrxo1z0fxljcZOpNLrUcG0Y/oufDw+j7N8pOKeBkVmCmnFwF4hctEaXk6M+
DEP8e1rm30TUalXlhuR4D2R3Qyp3q9mcj7HZxZLnoraOuk5w6DORIdm7GKnuXjO2kdkti9A7QGzc
YzaIU0m7wRxll0rKQ2GmO3n0v0lxfwh6fS21wb0ajypKoDmXIJabDbI+Zv5HI2nbzjZcb8hgzbYx
KuUlYuLl8+V9f/Z+tNjwonwIL2m27y2t9cu+5yBiEIv2tTbIm7RBl6BtHOfl8lDnXjWSL9BqlPFw
f5wNNYTO1DqxeD8lxcZhbkQTtE2ugfzPjwIPFpYGl7FQR3ufSJaxE4FCk5G79J1y37OTUBxQ83/h
hUbviohTMAmAws1GGbRETcw+cvUWjUHfk6OVlA7J7vKMnVkcDqKgsgpdDSyTj0cpBiOGozhErhAZ
BGmE8rYdZ94mLq51ZMVPmp1MRqJDT0sH8/Y5vs7oKj2Ackh4Z9rTDcr8+hKtdnun5TECo3GRX8kV
zqwS8R3EXDJiEmNtFnmklPqaVuWbJVThD23fRnej6V3DNp8fhXuSarXozM7uO4oIbSoTRbppW6UL
jCJMBOR5cy+v0tlRTKFZ8Rb4z/eCRZTaJ2LuMnMsD2bodCvyvfRK1efsXhAUP0InSq5zVVBe7EnV
ghZthEjxN3qTIijpZ8Kbs/DXl7/QW7HqZDeQWUMsBDDMAh3vu66Tw15qoHREI9cDjFfcUpa2Fdb9
tlKK4B4x/3xah6oVVwgLB42xnCgS9/tKT+1oUQXedLAkWUdofNByzK1lNf69wqrlJZ6c74Y3TWtp
aIxPQ2ii/B1jiFktstFJbpURgMOiLKxO37dGoeJBbpbNsy/3LZbQSt/17jCaEbG+pYyYeZDZfbNA
o27i0PkP0s6jSW4caNN/6GMEvbmSLFa1U6tbdnRhaDQjOtB7/vp9qNjYULG5xdXsRSdJKIBAIpH5
GrhmcqQ7xT0nvlZeQrVxkE8f8uGr2SRp74kGkYNzbQx43WGzW49eoQwmMpzgi9EjLdW/ZN7tGCaV
eo62IWJnq6DYDwApxuRqOR2Fwirz56aeA7WA9IkXZ4/ic4mqzfvRBo4B8FAV36oONXd+3zxdzGjh
p3YOenRea+fmV1HJ8mtnlrCwbAznvuCv2f6NoGJXeHEfYyjPnZ195cjc8S8LhOyEoZ+QnjJ6dCaM
tPMcdTD/0rJUW61HOwMU1Jhl+EeYY+zWmZVN7myZ5UsD+vPS50qV+u3SK4+sWb/cN1UafaozZJoR
lavf5zivn/oZ+VO4zOpTPSp9IBtzfnESK5FxeVUnx0X6iWqmZdbLFxy+bJoLoRQfmRDvvAvW5hX+
6DTtKelsch+pUcK6lA08XgxKw5Vj/9tjKOIiMvtebqr+vmxt/SAR2juyJN4WoQeEI2266w3exEgg
5zY1davLJX9qpeUUI99/UNPcC6qcInRDKPpxIW2CXB91rCfd4/PIW49cRjWG81IZU6Aq4fy0jEod
3D64ezFiFV0A6QTJDcWS62nJ8iiPrcG0tI5qGFpbSGCXFGTG3P50e6S9b4a5JrJgq4E0WPDrkYoh
XyhWTckZk7YOTSPNfsV8j/J6Po84zqjy37j4hgdxaW89IcMAq6EGTPq6/qjfasSiVzFaxNXsXIxY
Q7E/hzstnxBaSacf9Nfkg02ys5oUiQ0wLdxRoJA32WoT9pZSmC2vcCyZPAelBL+qkn8W6EcHE9t7
nTEUTR4q04Adtj1jW12aNit58Jt2k38MBZeJbDeKXwOl8RK9tlwFGMAqWBH7YxiZD41atadoIfmM
BvmIjbLzca9+zbowv62znac1rrP0MqZp9Iay7PC40nN/iHBbrDMpv3N0wt3tDbW72BrYnbXJS+K2
GbPriJNWw/lHRRVBIyOu/L6ajWCxMPW8PdTONlotfRG4hgJEo1a9nh5hP7K53Uh5l0xcgKHLQZSm
q5mf3p7klhr97fF2yCK/PIT/z4Cb63S0035SAQifrQWcXpROQI8inSphg3mPUbSDR49TuivTogjU
atS8TlgO/j7TQdK1HsrNtU7BHMAFJSXqa/bm0I7Ih5r407K3OND+0HQVReniG5YJ8inFb/vUtXp9
lptMuqhVf3Sc3kjEU7FHjQWhoZVMCTlokzMDe8KG0MLSFHJqRtOpPJWO7Y0ZgkJm/+9imSd9TgIz
az6HY3oHHuWRBM5jO+CUiVGsUn611PBOmPmzJQ/eJPqPau/MB4d+52ZAlxVwA/hYkJtbFuYANSpC
OI6Ybba4sqcFJrh9OR7s9p1REJVkHShxOis18noLZkDe5UKK6JHM9uj2vVqeMzs71INZ/5vrD77y
jAnP9so05lxdDyMLzLCqhGdzIwGhHmsnP5lZl2FiPYV39IOtR0dK8R8pRIjdUIztmdnI57xNft4+
AW9P3Nqo5NFnERvpjGwO9xj27WyFNUW/WC0fM6MtL7WkqWeehOX3utasy//feOvv+S2Ayei3NDjH
hYGFbpWvpyC5piVDjSueDcoATf10e7ytUBhXvE7fQQYzTkGe0sY2pBTaVGmLogd2T2/ED+UM/nNo
d1imLWBs+3eIYVcfgWjgSVJhe/VxXJYWGbM61TBjiq1Q8/HDaZBkKwvtoYtbe/YX4JStX0XmaJ/i
AUs1b5lbK/daDcdBF41j5TWsOCmuaJMJ80RRpuqj3cx1TW21x3Y07hu59bEu1r73jlF2OKj+UvoF
hvyPU2Tjd7jN+dfEKjtyXaAUpdvoaTP43dIud02sq7gltwvV9kIebeFhBS1MV5GkJZgnIb8i6iqj
WizqzkaRNMzyS2iUNc6wrNLjkHSi9yNTynmgSMbiKkI3Kh/DV9RFjDoqBTZ1WgVbLZ/MzJ8oTL1M
mdWjgz8nXzID17STHIaT8KxQkr/O4aC/YMld42JUTJN4oFs22T5d/NEaWiUQaFbnSNovWCArmK48
8evTx6HJG93L5iILvayXteFEN754vf3td1oWpKwr5tSkpGlz3q43myqJFFye5aBgoN5lWq9J+Fc1
TupiR516+ozecFbOMzaNeugqbWa5/LiKQ58kKAFhCJs40qrEjMaqX8pHaLRfBe5NDABsQV/MWpVi
qL5c/7x0arCiq20naK0WU/JI9kA3YspRGPizWIpHHvwKv1GnYTZKoPEy16iwlMarZplfzRnEctg+
VFbxge15ur10O2EBUjPdJPQ0uJGMNUr+dkytqp6VkLsosBBUGxcNN5BGkl+KpNS/KBLH9/Zwb64/
clWKXKhvo5pDcWhz/UVdncZxveDLh+EbFuCy7S1xOjzZOoXAKcUcrQmxl8yUv6Zq6Q6Sjjc51To4
U6TPsiqjbgu8y5Rr/RC3yRlOf+zmWvTeHIvPSpblbtVXPw19eH97trsD0vYlVUZGmahzvbiJtNj1
WOHZPQ5VeBZZ0X0wZ6grzkydVa8NLH/s7o8LLoD6aQ5yy7PIZOjbOCjBjYsHZin3JhnMKHA3xIbw
YC3f7Jt1FHIY7hJsUmDgX0/NySZ4A2i8nutIqe4iQ6ZsK4n4FLdzfxpDjJluL+W6VFdHaB2PQhVF
a4r0aNpdj1dMtCxFjAnpaFjv6hLWL0UlGxfwYnZp/CKlqVbG2rY46tq8SRM2A29CS41hHwZ8PHjS
PJHdfImGIBzaI+TvznJyM5N2g90H/LXF2E2m3g5qMgNYwI34jHeDFXQLRtCmPE/owx0y/97mw5CV
yQTXivOKS9jCwKQoktQ0rJHvrFT1YvZCe0XyTLuvInZqaye4gs69OGPAFD4okVX6YaLFuJem0sfb
H3ZnfZF/Qyd3pZDT196kYdWU1lJcRDEJ8fyjMLToXWLgG3h7kF9adpvtczXKZvugUmQ0kg1jOIyb
xIUNk3qq1P5LlQZ2DteHSx/mzqmnII1oSFDi82f0Nj2LjqbrhKmHFWdzopem+2MmY0i+Uqjm+DQn
dBwSrvVJll/GNn3f5TRNADy6SW01LvCHB4oq5qntuvbgQOztGKAHay8RpAdn8PpA1H01hJaaxWfU
xFB05Alzykz5E7C0wUfo/4iU9/Z5zIZBX8WEtUZ5Q9n2wycrl9Kls6IzYor/WIlQ/XTWtfcZlHM/
D41XQ5uzE5ix+JEA3FE5CkUwm/CsBoxKDoLPTlxdFdcAQMtrGN9qLBaa3ZUw/aOzU2npSdLGCJWg
dvFCdaT8IUxyQLEcFQh2ItDaAUBzYAWvwa65XnBejFGudGzUpO1eCtwbPzpRn39QwAh8VGK99oqe
4rArKis82r0782VoSi6cUzpEW8cNij+LMicJrlhW+RApS+xmuO+B4hH0sS1KiB2azoWYvk4WNpF5
+CIs604z6x/UM/6p8XXIxnqg9j78NOOMdq4g55OG73Q9LhGa837b9E9QKFIEn+rvllG2pz4vulNU
Sd7tc7hz2CEA8/pdcYZr//N6Dfu+xGbDYQ2nAl93x+qsAM8+46DmtzsKj8fVOAdk5rZMT5EzSWAX
RLiZ1YPPjlbhF872wQHc/Shg3mgJQaDgWGzmkmUZDUTUjwDDLB5yBGhFZkK5Q9EPQ++lwAiUCtrB
VtidGryNVWUC/Mu2s5Zh5uMMlhadW935UXeKcjKiJD/ICd9WCUikOeUowVMUXnuF11Mrm1BPbSAH
KD2k1bNem4rbKot8ioq4D4pIEz7VlOwE/E/6JFV159WNkE9gN5MPgNNGbxwmnYq3bjwPS6f7dAMV
ctjGWh7SqhDulPX8KeFKG/yH7QW+BMECqthvhBjTNEnCTpL5JL0zuqaKxBEWhT//yyCo/5GQr5F3
c5VUWRk2ds0gstl2Zy3FN95siuogxO19aLJkGBeUbCjFbUbRLLzN6WnxoRcEKtAvbbx+zQpuz+Xt
w4kvvUJlVrEfKJPbDDXvM0cPrY5IGsnp53pc9Dsh013CJhsJHmo0PvgwqBMjqOalml7QcbFACACl
zEDCX8ZpHtwya0CzFEV9UEHYy1Eo2suMsnJr6K9eb0M1olEfwT4PuEv676DJ8AOF+OXJ+VLfy0ab
8prmboFkoGN7IaAa9maQopZ7tErrQJvsgf4BJEAkmlZDrk0evywYDfVZJwVzXjrPOGI/1pFkXxY5
1wMj1fLnohpXk8vwJ02p/GeoRyQAyzC9VEapvNz+ZDsbAzk/Mns6JqvCpHm9KBH6+Q0WXVJQibn2
EdhS3DiEWvOno6z4SbJtIFSryuPmsmtLBYbFgvKTKdTJlbu0uYtFdiSo8TaEMgrruUZQztOWWajL
s5kVyhIGAP5Uv6nm+ZKgzOepajJdVPAlnlyo08HJosT35nMyLK0L7lT6CujZXC9hm8xaY0xdGAhU
8JVEeazwff1BL8iWTxi3jucKXLLjVk7ZaF6ft+LVCC2sx5vcmBTEsxcu4cqSXwHazS/gxCQuYfnZ
TB3nQzTo2bepBJV8cgDZ0gVa1PxjHGvqj1oz8byurH42vWVI5G+9UPLJr3V7ligldbl+NzUT3jUO
DVtMEsNMRRpZW9KPeG2JEFZj4sxukschAv8Uuiq/VVJn8hOjjEI/HAzcaG1JbVKwLyJ6GuYueWzy
PvxrGiX8Xian+p5E/SzcLIXI6KpgZV+GvtI/KeOU/yw6tfg7rSLElZdINkbaksbAdsa2q4qk5O9M
75x3CQJHpt8WMkOFlLkndrk5kYFZYwVkxYTwvgxZ/CO1a05AmbXJd2l0lNxFfgDjHrXsP5vLDPMd
8sdnpVyqxW0wYM/OaawW50HtehBC4Fp/TLrSP5tJ4QC8NMzmMmOo+JIr9HlBHanSo9LoSXjSAO9c
4l6jR61KsvgWS/b4paj09kXoyuLWody+2HSPcJ7NH7M+lxBUs3skruulouBSjOFHc6iNB6KL9VFQ
G32p0zQ85ZSLWr8pnPmhpO3tXDopTXQ3Qw5N8tEWr+S/KyvrbFfH1AxRcyc1GuQ0M54K6LVJrZtL
oTMG8Lyjb0qxDLXfK0r/Lh3ibD43RiXp3v+ILkVcp1bBkSRWDBe70p0XKTMLTKEL45NApSR3Ud8M
30+1071G4K8it7Az0NNKLtkUiOQs+mQLU3rB/S//fPv0r6f7Ot5Ro4I8TjsMcZg39IGocawpzNIw
iFqkQcMYgYa+VNSz1Zqf/nwkkDsrAxUNDF7210eRzKJWmyinOo7YyEPVxj+7PqvfyU6bHKSee3MC
IKbicgN8g2z6eqQyjaJ4mGJG4mkQ1FHePCxVaHhtL329Pae3SHjgtSiToXhD7KQ7uxkqsyvbltig
QRW1yDRpS/5Rsuj0Exu0CxfJ7Md6S6cfgLEfRwM8ySw/Cq0bHXoYMr9+BD9AJgem1bMJcmOlAaUb
QyfII3MJxIRmrTE5U1DqxSd17h8gSjeuGdqjZ4QtrsY2xY3eKR8aqfs3cr6l0vjQdeFfiW0+mLFm
/uwrXCfbVKsObvmd70IhCW4hL1mZkLxZrKm2Fl3GNzzopHY4N7H9j2jz/gQ/+n87UP5f6WE7t41O
XxeYFswQWm+bF7MdhQC3NBEGoWGW/pAbtPt6y/KpZssoQQhtcnWQIH++72j+rGpVq54WeLXrfReF
CSbK/VqatiL569ApmHio6Xjh75r/YSlhOVE/4uCi8bw5TJbS6U5cMJSDDbTbJ1iQAxiq0ZPsloNZ
7e5xslL2tw3HBvLp9bQcDC5GtDycYGhGYDJlmFsnRzLaU7uozkkAs7gbuXxPkqEMfm1XxV1NJnFw
la9rt4lT1B65AZCXQnV7K9VsRkk0U6lwgiVVREDRkAZ5PNlBstCwRhO3+VhPvE6EURx91d2R6a0g
90RAYe9eT9+Q8ziVBGXzDnL3qSia2tXj2r6XBqRVMXyPPs1l2pzUzFAPPvLb/A8gnQX1BFMnap7b
/M+OkFNpIji4PSh3fPAqhf6Gc6Q2tXcqFZJvPi7uXaTf1/Mba3o1STE5QSGFid+mZvgdttcj6Drr
oCG+Ox9eISBmKKq8EajWSYJqHKSdQE/M+h1dQ6wfkuQIbLR+jzc7Bey9wSWjUGpcf8VvbQ4DxIRD
wsEoBVJOQ6O1gaZM4knGyPSpoPLq3r4D1qi1HU9dhcpB5lCbe8NCb9J4AmXkBFIR18/OjOhNVOEH
U5YD2uHLoPpDp2HZ12rxc9GMR33+vVBHNOWdwF5RjS3KIDEWEcs5w4eaNd5Z8eS8V1NLwlQDWRb6
XZDB5GT6cnvOe2fit0G3ElNjpYQg3Ri0pTX5ozXD9EGz8iSAh5e/zI7ewGludF+yzI+3B96dLZVQ
cJlQg3iVX3/czpyWBlwSH5f+GaIhTenbmhAXuasbXGXj8gMSXD9uj7lTUaYEgwffLylMXhKbCNCb
Rhoi5cQJUeLvpeD9wvM8/mfQTcnrtXkIEEpZGncodDWw0qjAbYkULpLaPAg7gxg95y2YRmmmeWJ9
MaSmft8anflOXRAoyNkiAWRd81LrDvgfmsQB7Xv1TlBcA5aJtipycAX/VOt/NEUevd6e3e72RU4c
vVt2L9Dn6xXV06mMy5EVNQopa10ZvNVD3zok8lgj/EgEOqqZEsUPshVpLra+zZHcyk78obrL5aKv
HnKkUtc/IG4Wi9cW10tXNt2TLCfiKZns/qmx9NxbtKJ8ko0hf7Q7y3FbpOvdOq7H9xLvOL9QMtk3
M0vc5f1kX0akxdy5H8KTwOiWTnRteAPW9F632OODKi2yOyK5FSLeeUFlCx3JJTefEqFEJ/Qt5E+G
PUxuW7WW7yDyd5KjNvZlFTTKxG/xzEVVHpAYRDVN0WgtY/FLm/vUazRRdBS+aKDqcVef7XwpnvQ+
mb8qSpTd3f5aOyEU5UPkfoE9UPjaJtFyL2pJbthTRpcPT5U9OCc5ibWDkLZzvFepdzpUKF7Tz9zs
iTg3klC1axJKQ7JOUT4hdlopqR81LaWiORO+mnd5UHKZBLfnt5fLrrgVdD+J3jxMNtG7TJRhHMh4
eVOl+V0Va/XwAFFdxSDPnOQQFc5q/iaMVLmrIg6EGmfosonJOsEEm2YP8If+V4GV14euwgXBQ/JJ
frTlGL+zRGtbJJgTJbmLF2v8Y0bTyrJYmUzEpdXIexOZsjmzJSGta1Yo2kXC7dKz1KkCnl2X/qLq
vW8aGnJz5PKB5PRHIMK9U4QT4nrfrVW+LRY1AvAxzU1JkpYDsZ3VUHe7qhUXQwkPQvDeFgSwRamI
AASYV7s+r0lrW8jgMVElGaIgsdHQi+RIPtiCbylrrCfJ+5oAGUCHfzWpfrvGpyRP8nZpyPCacUwC
Bau3xgVviwDfRKqGid+QDh/apoleWsdY7sdQJOKSSCKh/QG2kzdQOXeZ201O8uH2Jv2FfN1c+WvB
DGwVFSUKS+st9dtvKx1LSkNLOMHYmX4tOd+mFKSh3OenIjIuVZk9DKV454TUSCL9NR/lv7Nhearm
/D5qKkyMx9NYJZ4hFx8GCuNVp3mZNV0kpTypSBlLDrT6iA3Ta4MPh6dxVaRlDtZ35yKl6LfCBlCk
XP0Wr6eQCLPPoDjYAQ8kkK49+JS86nWv1Y1Hxek631qBoQfrtm6N7brR2AevwFuZRH4TV8QsZ/2y
mHYwW337MUxS49kBNlFQ9J4yplt3jsvrvfkb4rr6FcT12Lht73yXGkpSbj0k8/MM2fxHCLax8fVp
ekqpzudubCTpX6qkIHA5o5T6RWRGhwFkiYaqN4eh+jULU+WIzbtzcbKCtE5QVQTvtH0XTD0a9nEx
20HnfBciXx6Qvs3vigpYmT2g1NzImYkNa5OdtAjmw+2l3OnRrtpMOCbSNCDMbgmmIlRCq4JPEqT0
g10rrR+UsD1LafNRjmxa30oRSL34UDjKa2xKP3WoMmrSHknx7u4ii9YR76Nf1/f1LlKQQ44yEGk4
7jnvlDFe6/cL92WRRCcnrPE9Df+9PfG96LP6HFpIiqwE+U2YHXuB1hPv4qBSRjSIctvyypgQdHuU
X8iZ7U4lwuHBAL0YJvP2hCcySi4911sXzd8g7doBTrMQUwCI+2qWJ26V0QyvaKjcTVnRXEAc956j
xMYnO5wgryaWfjaVqD4vy9q4TYrxQis7fpxRbHxAjFALREX5djJj8Q5V9z9vWK6i6ismaAWZ6Fth
9XbRpKKtNDuoBzV7oMWnBrI6tm4c4ZrnLKn0FEnSdBBSdj8NOTKMZxhmIFyuNwP18AVllsUOqMyk
VDBr09XK2jjIEPaOHYVK2FK0K3nlqdejmEtTNVo42oFQ7DKAtWRSFh2doF7K9JNhJO0jvmvOQ14M
9odG1OJg+L1qCEWQVWAGZYKVPHw9ftgMtSMkxs/mFKkV0jFyySy5K0FGeF0YOx8skYxkAePiylZG
9dzs1YMfsbvSK+wLJB+34xZaJ1UJ0KuB6ocd64o7h5Z+6ZDc8G8fgtujYFd6PVMDvOJE5dwOJK1p
H/u2QDHAkbr/MhfwcgoAM3gC9mY9qdrMFFhatqrSYzXQK5Yf2Yi4/Ie5gGVB74iUFijb9VyEkWm5
3g/szSSOCMjmhwI1xIOgvLc1AeHBF4TntGqgXw+i2kWHZDDRcIoL9VnYS/JucUjEpNlOL5qw0AyZ
cP6GfqWeHNBmB3Pce6fS6+IX4M8Et3TL8g8tLSt11JY5GrGFzlTaLPC8sx5zg9q2v3Wmk37VtWwq
XUyVZPyTZUPKPO7Oybg30mGxXax7qgiXnSL82Q/U3FxHKgfbB2hk0esoDJRHlZl5RHWpoLbXODB9
zVQXg5fVVvW8YAyHoXHPn66U1WsnxXLyV8Jn9Ko5ov12+6PuPVPItekbk4OB7N+8HEFlxNVQC3KY
Eno4EHdcTFNuBSia4yXlTX3qtN7wJtmaP9weee/eW0nCdBSJQTAsrr90pqq1SUOdW2iJ4vcNdhB+
bWZflab5YPf2a2wtR6BIk/9xeyH9PuJmA+vCBuAicw+hpezTRvkhLHW5wPzylnGRDs7kXvKN9wYY
sNVsk6fYZifXTZ/0Wc8tK0ap+Jo35VS7Fbrep7pFqyIm83gEUE+HY5Y+x2bn3I+oU/qTZmdeb/f/
1Ir1x46AkMu51ld2H0gJ8MTXK944kt1L4ICCCNW3S1How/3/w6tj57tejbKZ9zLETRStgXVGlOCM
mrgeoApo0lVs2/dZNCfPkvwf3lNosNkgmChq8ezWrmfG3h0lZw2zWrmMPASW2TPX4sbtHftWwIsF
REdn1bj5hfPZbCATI0IFj1+L4pI6vBi9E5Ov5LU/xUp8aiPF/tyk3RzMbdj4rT5r96VW6N/pPw7P
ihGK+ziTJG/pgV3c/mE7QZOHwIoK5fUsU1S8nj5qsXo3lCjU4LXYuATJdjWZ5KXUry7FWU7zDLfv
YDC0L7bcDJ9uj/5WRMZB0mldEyQSYORvLStyHiILzYww4Mk4NJ6TRuNTHBpD5SWQOJDow9/Qz+w2
elXqVTtlJfXHbiJJ1sPS1QbWjmCGXbvggeJLdI1PmDGJOEjLRKxngdPlZrbQD372TuSDTMvbeCWF
AozcxB9rUg0pHdeKk6OOT3Pf5/e1VPefHREjLzKgl2JR+ArkNjQPuDc7SQHtCHrFUNWBjGx7q5ms
UDjrEUWgdtT/o6RT7603xwH7fmeUXxBITjo+XW/kvZxUpIO52FagzJizuo5daa1r6FXu3v78b887
dNPVRByeHlFuW06WhdVoZTtYQdg6wpelLH6N0yb1DH2yzhPPHjd3wuz1jwddmy2gi4DCrKCY6x3P
dqyqTMG6RA/VtnYX25nfl47yJTTV5rGsluJHY03mQXKwE9IpG8KJXAsW6Ipt2zx4GiXUn2IrQDw7
uqfg2r7OBrUFO1I0tFWpl9ZKFb5rHDAn02Q675APqYLSpInZ2nSvdav68wcDZTKOPrXMFeq6xQTF
vR1GdquZgXBCcdGyuj9jaVsfVB3e3pyMAs8VPT5wXdDsrpe7Enqc4F1mBjjeiUtDPuGjJOKjqDfx
SCmPRGSPhjOuh2s1p+3YVWYAC8j0WrlqTs4Agle2+tBXk+HPs3SOP489OmqrBfav7/5bLSoRUiMt
0mwGk1Y156mjBysqaTzYPm8DDqOsCToxGrPHbZepaU0NS4fWDMxQzXwtbKeXQYs0IHgS4+GB/GiB
OPCWZDoiF67rdZ34UGgEi82tT1GYhvf1eoqocnIxV2YAAlryZtEih6eL+i7JrOGoFfF2KKYHnIMF
hTi0rWxWAnkcEkgjSMpRvYOWF97JU1anB0FnZ0arABA2GXTvyek2qQw1gzyCdGUEIpaihyxJ1csA
jCgoa6s8iNY7Q8GqpVGzIhlhYW0uV72PEZsoYnjdiVQinbfUHs4jjl+Vy1EpaHeoVdhu9SoDnrX5
TnEbJ20zOnpQGEkZSCMSuNGojmcFMuHBZtyJ2niCmTKuFysgYAvHppHWdPGi6wG21/BssxDxxzgy
3slLkn1RGkU+U7JbDr7aTmeCZeQU6DCqIUFtKfOywqMJO2oNHVsewfWItN1UQT4Vln4/iKxBB3PQ
X8dI/ZE6WvIh04AR4gWTBNPiOOc4M5T7BS0R3xR6F0R2JoKqbWS3Q8zo0QrHz398yfwqkpEv4x6H
0Nn1seFFEvIIXOg15LpNsCM2BJ4OEu3S5GF8uT3YTszj3Un7mbVZcdLr3vgtBtGjc2zkn/QAG3Tt
gdTDOEuzNKBziAHKLOXjH6P+SbOA9/DaRZoThOX1eKOoRo4wiNxwAbbZKLCccztPDma1s6N/sZUw
dF5lKbaHx0qHtK5EwijmrL+ajphPkVg65P4J57cXcP3BmyDHQxaCOs0jIOBbmCoW5KLQUouq4Nwo
z6HTRogSJEep9g7YH/Esojgi3DSzaWlfr1udW5OBZKsaYFYs3UuOHb62WVTRlULHJHMTXSpPdl1N
d7iPTf/mZTMHxaRPdw36EM+0aIwHx6QdaiR1uSC6IwT6FEqG90oSu70VL60HKNJ8b4h4Dv50gWgO
U85ca74cPmsTyDqtLjuzstUgMyiyiyr8YdtN9F8GWaVcEANFF3XbQ1PqJe8RUVYD/LwHIHJl+82M
6uLj7am8PSzYJPPMQ1uKIhF99+uPoOdRliJGQGkZhT2XPkzsLV3HMwEYBSrRyZHz384T53pA9XpA
aYTpnU6mhdiF1N3PoimpXcb5v2OZJffxYwzXT+kHj+eZhdRLz0ssmeIAWajxrxynKyjhlvPatmV9
shJqnLwhi3NbIbB3e13eHjd+Jm21tXxMQ2Xb8NOSpQa0Z1nBnGS1V/ckgtUo9y5YAO3gQ+/QDRgL
7QCKuMQrrpLrJcG3yAHDhf12EiGFCPWs8ZWyVDypTqcgLCoq5ch338lV2fooNc3+kOmSZxZ1cRBj
3h58fgjmBmsllwfdltqnO7zQYHxYAY5kw2UM0ZbXZueoeLRTtGYYmAS0AyDMvMEoRcUi2pD2NV2H
CM4/ZKVLFMa9W9s1ryujQv1lRrJR4EL2UIGGRiFSUQ6+795UV1fNtd8Ijm6LyyrTmGcPPf8gjiwd
z9W49DS51/84kpLoryBj4As8LbYtRrmylXI1ZAqSbrT8cB7nS1pYxen2Xl1TtOt4zSiQeJEQWgU/
tvtH7psJFo26UtosQIC2Ml2Uxfp3jC0e3aoC42nM8nuVHOAg9dk7JKvM+VriXbV71h/2202LpGwX
ilpnEZfKeuhaIzy1ocAqXCmOhtqLU0QnUm8gpoiTaNdD4amgSdXM9xr7qfCHlI6WoiQprsodl7qh
//lD5tcTjRYRCNqVgHM9noLSdStNoxWY6lzeqX0iXDHE9kHqsDsr4vt66tcAvJnVoMwrcH+islBY
tkfXpOIZnhSXJB8/aVMt3t/eKL8oYm92ytqIo1RD+rg94Al1vxh8ICcPUNOpLOrJC51eBYM8h4Ea
adHdog20kKhEAF5NpnsVb0hIH5W45BN6vCSKna/InX4npxqqEfkg/E5K/oGJqD7RyVOA/BrlRemU
6r7Lhr8WAb3CUcAmDGHePxeFpZ0gPUQugiCRryDF7ncKOJQoDQuQ/kt8vj3hvfWlikZytlJ95G1f
Wqt7rZoXKipSI9RAiCwMKDswHpwA2o+acoQpXT/YdoEJa6u3Jn0ApP6vt01GA1AOY9sM5q4s0Nnv
Hc9iHf0YTw0virTKbaHHXNDcNS8j+VcA8wRjgLGJnxN9tC91P2iuFC1zYCwY6oheH71ZhkkytLni
oqU/PPWY/jxG3I/0Tez23gnt6WKbw+j3ywr2HKP5zlqcxgMCJpeug5rwpWpC/JFx9tBaVGvN0nYZ
xTbLCdut1Dirs5Y+lBPaAv9TKU0XJU1jBVkOgbKSlvZepNx7C03GL7c/zl7Y+n2tNpu/UuqYPUaD
qHXU2m26XPtsdIbyXIep5tWaap6RlzM8B9CUd3vkneAPngshOYcnL0WEddv8FremqHT01koIy4NR
P/YT2uqKaNvL7VF2oiPoOK509EzXGLlJrUDJTpkJuzkYRIftozCqS6KVj5MxtQdh5O0TFDuu30ba
7Lo815A6FxFhJIoMT1OLEUsMQNrSAuTIkrDMbWSp+S+LCHeCHHhNUrfOJhJ8jq5uU24do5jOhVNJ
9AzSIzzz3iJSjac9tjaAjG2hMK7jqNIrCoVZ06NQI0sFemmjet9JxhFmbncoosUKoAHLuzU6jqUm
iQxFWCSbWe3XjvoBtm96aUtQCrd3xk77gyfPb0OtG/S3DVjmogeza5qBZBrWk2PFVdCGZfaow8EK
Jiesvkml+JnaU+eaQx3fJza5Xl80llsLuXnoC/OHAPB/kBP9X34W/Q904naoO91QOEmX55wLrZDl
s6VgmunPdqmqp6SUTdeG+4UsRTLOz1W+6I0bGnX7YI961fo1DhgXcy6BnqFzVH/NOnk6Kp7uPBmp
vq9NTuDBeEltRYNQueLjD3wiPTaRnoiDqpweFsf6pjjLcyyBqpIVHjA6zLc4fa/102VQ46dxRTz3
WfJ+rqQ7Uyk+l0bnzZr8rrUkb1wQoL39ed+GF7I9CndcPLBhEAe7/rot7cdOLY0lQFA/vEPlrfdk
dAAPNtHbu20dhRf66jPMI3FtZf22h+xQNnrEyJbAaOOa14B4CrPwnTK0pmfJUD3/dE7cRpSsASHB
a3lTwan6MDEgKqlBr2p1AJlQQGJtpU+3R/mVdm/uz/X5AcOdjIjKw2ZSFImspRWUx21J+l/snUeT
3ciZrv9KR68veuBNxGgWwDHl6UmRG0SRrIYHEt78+vtkqaWpg3OmMNTqLm5IC1FFVgKJNJ95TQgy
oB/nW8+Khn2XdMh/4Ud1KPRWXEU4n/hiqcYr7O3qHXFxvp8nY9wrWAbss2JOr5Q8Nx+8Pl3u7NEG
+871uk/tRfvyf6BjaKDgLezaBabXaumMe3Atpg9jagvZeAEax5Kl2o8+mEQQr2X45qWeIycz7YPU
2Psxi7by0dcZdqlqou0eTl2gGIN+VPRieRt7JaBLL6H4URTWFY39Td79+drkcShSSWY7TK+1Dwf+
u9Ocpp59iCW2pW0KVIz0yDxaoYkkXb4g+OsqSVBIfUI1t5+aoRwgnueZT2Q/+GOj9lAmF7GxvOR3
PfvuFFOAkpN3cmGeLmZPAdWTEywc2ji8IyQqP9hZVH/oBsSMhao+2YkjrgoovwdjQaHy9VV3aU7I
0mjvodMFU2d1UevjkKV2GtoHUsV5pyXTgllRsuUPfb5f4ashPUq9iGgUVcbTV+y1cGwpftNoq3Dn
tcJ+vCvn/JMJT2Ofdt6vI5kYDpc48JgO+dkaoiCpGn3SOPahj0NnH05Gsqt1lLRfn7oLjTyGwbPC
pBZN5rkW/Sra2NCUkQZTmWW9j4xSHlBy/7Lotbeb+d/fxhnJjaaxboyoQnfavXcVaxf30+fXH+R8
drGYR2YSKSQYagi7ns5uo7eaHeWjfpjm/CvJqh5YCgToyMtdIGllt7Fez2MFhoMzJk1QbQqAq5JN
bQ04I9ulfjAXRel9Cki9P+RFfKvblfnLjaDTsdbLkzsV6ceMQmCoTne2Pfx0dOQ0/435w3AItWp2
H+Ztp/OXV2FmNTbIzHmGo+r2nro3ZlHtnaYjJ3XmrcrIpQm0IF/LSQS4b8qQ9sXthSXvLAHD2mFy
ROdX6NW9IYws962lTfvXX+3SUBTwVAok1LTpPpwOVaoFihJoewFPKNV9nwAhUzsX6zUnzDaGurQK
bflaHCJQJdftT3R9IZDjCkGqaZpvjEqIG2R+xT4CBngbirLeWIZyVZ8em9zFFEVgqEhy5hrjx3E9
Z3FS8WqLSklwpKy3T7B+JePrin2o1sVOgZW4m3JvawecH5oMrdMjgIlL/LH2oQRwnuhtlGsHjO6b
Y4WDiV9icLMxoZdHYT8jc4T63rrss3TKXGtuouHmq5lB11NhQvtgy9/s0gqhB0oqiOwQ5LbVChF9
I9Aw5bNJVwBYXvOCdafARMasm40XurRCAOVw85I4gVhZbWaktDWYZbV2UNM299NosndN3Ou7iMzf
7yARb6SGF+IP4MEatmrIeFlITsl3f7HRJEpvGRVkrnOtS94qLoJBphpZfoYnw75gAcW+gZ74zvZC
/Uqt1eXa1Os6aEqnDcJRlBsr9vz9eRxyH2RkpKjbunUStqSpNLXVA5Ukez9Xbg+KL8PUDdroHrrV
46/u/dPhVtdCqVbawBGE72HrQoFS6+Qwcl8eYBl/fH2k85VKvM/Gl4oxxGXrA61FSaEoSkaSeh9H
rw7Hfa6V9Yb1zPlKpZXIzUO9lQwSZtrp13TbEp3dylsQm2vLa0Ly6FAC/7ym9LbVYn6mOp4eLiDR
kB9CPxZYEC2o07G8si4isk310PdtaASjOoXfllK3jF09ovzjD0obZrsxDxeiMlzVb1OApuIQNVXc
3/BXxmg/WFFmvpnyRrynbxJ9KVolQ2WHFb8DGRyhrLJUmA0vic3it7sGfdoycdv3utL/AAMsPuES
lmp+KPrlS7qEzeh3TQ8ZMh4Und5EOub5m9gdyQAKLa015H8VJiRrAL1OTvVJzUcNppsxmt+stuf0
nWSnZferH94mkweEQsVActZXhwd+TnRL7UE9TG3RHZspUclO4/jr66NcEMzitJWVTHoVlEPWugcx
YSkkNNTjw0mh45uM8UNZLg3SeeghpHeWmJUUhkNppTtMzGrIpe7QvfVSpt3PQ2O+SxRrvM36sHvT
LVkIJxCE1VZKKk+v0yXDiqHYJVsqGD2tYRcLdCe+tdZRS55QlbdFHND5cFEbHt1l2k2VqSy+peiu
eqyHHKPOMPQA87a5bY1UQEaz23kgQm8phoSPVtskhbTF6vJrYYdGceV4HdFB2tUGqIak3Vutg0Co
UYvkkRbx4B2jxGKAGPnYxW8NPCMhY7lQMitQV6VPGlNqPuADUQdmW4VXRkf9D86zrj9A8FnuEqd1
3qvmhPeYWndluwsdvMJ8dMriMkBnst9rOjIlgRZa3uSnlTrA6xr09m5ORR6kMFXhCBdZ+dhaJbau
rapoXxNCk/ukwmvlai5m6jZoy+t7F9X3CrAIGPUgTFEi9tu4Madd7lr9cGd4RUuuZcQopcQ0IqkB
U5B/fUGdhw5gcAi9wCuAZTLXmh2jmiX6VGbzwZjs8layWXfGGBcPTacAZSm8GBp4W76xs2lLcvb8
pGRkkBnUDkkZzjgW+KTSAPZoyjeWOlzpAFJ3hlsOG2vxwijkiwa+Ktx5DnoVp6cX4aWpjCnlka5P
R0RkF0wPzMn+ZWgodhVy70veJSHf6jzWrNpBkq9bDlHVJbc26LAgsQv333iXl6OsgoashiRuNM0C
rajud0U9VwfPgMn1+oo4v1t4F+AeRAlMGNoRpzM2utmooHnFjGVl7VdNYvhmVi5BxAm3kTY+mw2u
DgogdKAEOTMNMrZVulHnjTHUsw6iw+wpK8RTkX9pyKeam1zRF04EJa/v2kmNylsla+BLx8aIw0yk
zpXip4bi2vtuMbtHIeLhznPNODya4Vx/8qh4x0EjFFhvAjogKl61p/hes/TY9VWl/tCFsGV3Q62l
W/XjCzuK1SZrCNJyAaTb6fxlGdZQM3XRw+xm7s08dhENnFZSalW9DEq3VfZKMVOLj2Pnl+8giadj
YNBVhC9rClZejileOCmfLjLVXZ5CjKd4rP47o0isoIS5uSSJpy8Ygeh1ktmdD6RAVFitYtwpRriV
WJxHiJISQKb2T0zK6SiN2hTQF03A/7MRf16soTuCUMyPFdI/QeEhOff6sr/ArqS2R4tG1i9ACq5D
0nGx86anC3sowDzf5p0+VIGWLF8iI0Rym83tT4I42Js16zM8Ke8t/vHi6ICS9A13KN835dJeq1U0
YAKGdYMyqAi/JRVoplGvr8ymJvYW6U+zU+NPEIfKjSPofL7k6cNpSu0DwMK6h2y3wunV2pwOjamN
h3Tp+9tez42PoTXpWPr29kZIfQGuIntasA2RpETzwVydEwQ3Q4imy4Takwd2O02imyRuw5tJVz/Z
k5EekCeBOoLa4RXZRhFoldnfJ8L49Pp3u/QctGpkuC179NQzTxdKPYeprU7dCFS1FH8HsJVDC6Lv
97YSUfOnolCOAR4wFuXeqMf5Xak5jYMTnPNYmmOxJVJxfniS1UmVN8JAyYJcBctTnlgsjWcdb7qJ
RuP0dxYSc7tizvVfvg0AClHM4NaWWHJrdec4aYxdVM5QwzBG34ZZ6XctwJ2NTOPS9FK3phJEbCBZ
5avpxQHLswc7Hw+Utj8ipxMG+UCfdl6Qipnyu6WzbiZnNANFH66tLv1OoWELAncheSVJJJ0ioSK2
Bg59+on12XKGfI7Hw5ihnmSxknBX1KM3uWnUPlW9ivK/Zxymsi+CbpzbmzDFxaFKoi4oksHcOCnk
wj69tHgaalX0dei7kFCfPk0mKHoMijUcisQ23otWLLuxr6INHuGFlYS6OzpqsttJnX51jWi1CzGi
ZRSl1msk+KP2Q7fgXeKritFuvNFz9v/ylSRZUZbZpBgpSeu6ijOOkMGJp+uDNqo6Hnxph5yZqscJ
IsZJTMgcNUvlC30wOmhZZXE12FV/m2v1N70oenMP9Tmtg6WuMhPcXrQUfh8Z4+emHDTlBjPBtEEo
IS8hdhAmP7RdPHx2EPj5mQ8V7k4lfrjpoLJuMP6ytzKm9X0s340SHGeU7HaAzT39XKooFRPZMIxs
wJrtB5Slv04oM//oMew56F3svstDK//mKll0bVajc28KRfioONM7SlC5FubQ3DaFo89+mqkeL6U5
V6BvAUjHUMpfP83Wa0s+LFVQCjSgjSRe4PRhGyEUO5z6+jCapRPEy+IQuozLRoi3visYhQWFhgk1
a4Tr1j370GmkPkBaH8CMQRLtSXTyWFR+mMzfSnAkr7/TGdZTDkd5F14ZEHwJgjt9qTxyC6ytATWN
bebti36ed7052DtFOju7i9UCp6yNd+YUm1eqip+pV6TKVWvV39Nm5DrVo3Zvt33r65ne+dnS1Ndj
T7sEgOpWOnTW++ZZdf4rQb0IeQMAWD0rCLt4ICg9VLEdPzhzndwZeey90zu7udaUiu5QZ4QNThRN
9R4+5vw+dSpZ9Z/BqKRmKvRgaSvj3eKZW7LoF9YGHRxaDeha4MazVkUvZ/zQLVHUhwmbdmh8RnzI
qmjL1+HCdiEKYhSIBRSY1nUMp1axhAkFRtRzkz8gz97eYzY1BH1SWvciLO17dGizfYyw7kYqegYI
Ze6xEsBGCcA5aPA19SosdNT38Do55FbxubArz48MFSGWJlP7DxMWYQ9hCwHWbMOvIrNRZ86mceO6
W5+6CElStFddKulwiii0nH5+TJwtfXSM4TAs2JAnjd3e1E2sHJHS2JIXvziU7FRJySKJvD4dCg1U
JelcdNaWzH1qs9m4nqvki12ILSLE2bzKl7LJCcixSAzQhj0dCa3wqhBOMRzqECNSNcaWx8ky44M9
N9G+zpBqmZDN24Vj3nzM1HLZm8Yvkwl4BnJjGaB5RPTG+oaxI2ZbG7z+sLigLoyk6Lguuq3j88Kc
ygzcNSm/qhglr+Y0tRYP4mTYQ3UtM4CUbRiQKPW3BTWAjTvz0lCQsizmlYI6LdbTSY1b4HhOZfdg
T3J1p5lRflNVc30zjVtieOsdKacOTCj7gmo5bgirNblYxjTGEQ332FHLIFLos/SulV012Gb7xmK0
73Hv7Q6ghLZcMs+Mw+TQCEpRauayoG+2eklc24xmFE1/iJK5xzTM0HxL9JDqvajxtXgpK5+aWP2h
jWUOri5Huwd51muNuJ1jT1yFOjku2806GEaR4W9oLh/rsEw3cp9L30I6sEukjcTayJ+/bG7Qwwhj
AKUHdQSSYCNRf2wiMewBC1sbn319CAOZkCBrogmOCPr4q+SXiH7uMZevD14n1GA2CYv6Mdy6Mp8R
qS8DMoaxKI9RPpV4N4i5p29E3ROARFSJQ5fCstxlczt/N1RWgR/NjnszYbADKwa/1Id8aluss+MY
36Ry1hvNFyP6635mtFZyEKWt7/LYNBpQgE63ayAPHZw5z3spnR6Koxigs/vk7+ZXrW/pwYolwas6
ytpqJpEdsWFACVHczHqH05+aJBwbKrbR/uyNLeCrtEnaILdL9ye/SH2yzL77JEwjinbp0A7lvkd2
C/3CpJ4fsFytPo0eVA8/TK3Y9Vthpp/HXrR3WaNSXNLtYYgPXmih6+GWWv/OGjRcdyMjk9I9iPOr
cbF8LLIQwBc5j98kprmja1UNezNVFUgDSuJSbLFF+3Zc2jnZCM7WYRMfBT1VGRlI4uf55eCl5mim
ljjk1TDtVCMTx9HzsWkSWuJsjCVPqtUCIDyjxk9GD87KXi0AJERmkNuFOICAbXaFp4c7VH4zkDd0
sIWjhDskQbfu/md5sNNRYbDZWLPKMhJx4Sq16QUMUJDfCW/YKqBHEzPPdoXdSF/yYfHeWHXu9fQM
xxQocMiPEUBs1B+WE2M1vczQVhJ7Dr+h0bOM+9lO5oe6zyrraFZdGx9MHQHcsAntjL5Vvoj9hKT+
fG17TfJ+hsc7+EoMyXuf1F2o+yXWD/vQi5FSM0jip0BJjQmbITJEfUcXFwq+U3QRpOnI7vqDM0ZJ
ho6EpiJOb9S4y+IdNi370U2M+brJpvmHahbDu3myq2tTWl/OKk5ZDGP2HxW2PEbzy+BV3BoWJJTX
Q+CzQqflEbbBVUafjwuY+PJ0P5d1pxaKaDOKInzOVElpqxZ9v7xNFpEVcE6qzNfVxijZUVncXXWd
MDrKap3ybclRrbpWl6F6MvolAf5GPdXviwIZJzNRybvSGsd3vx2WnLbJ0nb7VAi72EeputRXqNLh
6TCWc1W8ff2lztJyjiaWiPSHMUAFMu2nLxXHvdFlfZMcOkyyYSwNZr/sTEOp34azpzgYSCaeCDIl
5u7IodI1u2ESXh6ICUbZvnJNjSJ2WP0jjPyPE5319r/+kz//qMQMGjfuVn/8rzfDU9P1zdNv94+i
/e3Qlz8fu6Qq/1P+kn/9o9Nf8V/3yY+maqs/u/XfOvlHjPTXk+weu8eTP+xL0Ifzu/6pmd8/kal2
zwNET5X8m//bH/729PxbPs7i6W+//6h61Jn4bREP//tfP7r++bffZVv5P17++r9+9vBY8M+Cx7l4
LH+7bvPH8me7/ndPj233t98Vx/uDZBg9S4Jtivzk/b//Nj49/8jV/qAZRF2eg4BvzDn0+28lOrfx
337X+FeUfYkmOR+4maRmFfzZv34EC5LFAOWWbBvrht//+YRv/3HG/OMrMSF//fk36jFvsa7p2r/9
flaSkMgZAFWob8mnIFM9XVzlNIxlKWJEVpKsO5aRXrzJxOcMY0m/ifT4GNvIbXaGlnxFX+anO+rR
W0edMLhY2p1aazidZEPI2VB56DDPlR81c2r4InH1vTSuRzhHnQPcb6/iwfyBAUf7lISooGYLIOEX
k3/pVdbt0GcQEA0oqrroTJ45t8XoiyeNQQd9MVicUfbJEbPw9XpEIN+e4v5hnudjXM+dHuixIKZK
xWQEVVQNV7T+kjeVTqE51yb7rlYm40ZVqWsJt5yAWOdD/6FxM/F+WsQXNd/SjXhmpp1cCNC5JJaB
tWDIZsaqHqG7WVJHoFoPLfL38V4zm4/IzkxfK7NGjcaD1h7Yk6geq9ks34t6/IRFpnpfRviNJEVZ
GIFplOnbQS3E57Re8tnXWy8EzW73RDJeMT7F6GZfl3H3FXibcV2o8fAIBlQnAJiL8l3n9lWgqDM9
WASzrhsPdV/fi4n1/KoDGGzmpTjMcfJFtfMw2gG0CblEZiv2fCOhGPn8IX/pZPkfT4mTk+V/ef78
P3iyyEDjfz5ZdlWRlMkPDpf3T6L/nic/Xp4u8t/+dbrY7h/Y3nDT0XylRi0Pg3+eLo7+B5LapE5U
dFHp5C+8PF1wjZVCDXD8EPSQy/Gfp4vzB30NiQcHG8wFSp36V06XZ8TYy4VNu534Gl47FW2qgmu9
G6EAO5iNHMR3RxX/NsUnez5A556WQ5bl6Ued7vS4d80WC7QlbNPh0DpdU/swgPPbVlMrfWdQMaxu
Wiuf+YueOhx7beooGvRx8rhgJGDslrwyfooiFMUu427E5leY/acyhdsf4K0DpEXvIvAaVZ005TVa
yZW9g3PnfkpKDQsm1n0zB0NnwG1MStcEfI2mahGUzqy0fma3bnZf5kVLJDyMxGVe72AVmqTmjG1b
RW8mKObMeKBoZn3WIFGJQOtRJMDBZ1Loji6tI/Zh5QxPXm859EyUcvrYqIlTXGWkJBNKorY5PNRx
0Uf4O7XAJRQvVr/Hnhf+TMuYHAJtcbKTQR+7D4AAc/u+1FrhBZla9fejR7p/k3YLhVPw7gTmiJUW
BZf1Ap69peaMB3LUznSGIqwyDh0Av+KBm1C6jReD0fuz2gO807C+YjuXffN2sJZo3I3dkj5qgBaQ
mLX5l0FjlhMVQhOzs8CwQ0UHpIS46a6auj7+Fnel+kbBMlUQ4LkVcZfpFsPDOEOqO7bJ2HxpC2to
J98r0anZk0LU3lUNLfij7k2ZGQyJV9whJoAMe5hMxX2IlMTj6LjpGyeznO9ZGZktDJg5U4Op6iHW
aVEqBTD7OaVB4XWfRe1lbmAIVyV6nSjw7eJQMb4vzhQhYzSly6fIs8bRH51wUn3NRufuUNdxpfkp
IjpJMFetPtDM1gX4AgOC+LvUgQ0nA77BOi5KVRs3Ju04HW/YEV2Tivsb8yZLa98raU7hm3Z1eC/o
oBI3i8Z5cnOx5A8yoHvfDbTl71JzwIpT4GSV7RYTEG7g4b9U7NxiAlmWh45T3FYkw+N1qTRNHQw6
xOydwr7odm03iSjIkaSl2azVXRJoQ43iilrPsbLrC4sMQiAuGx7RezTvTbtIuyDqUNEOcMS1jONE
o6HAhmqucLGs2v59C/2jh2fgjD+0YkSwxFZAj/iRSsfxruy8+muqd3jPgR4Pp8DroHD7jt64VgCq
bLnuzbbVg94eVWfX2Mag7TqtRPUawjBgdMzNqw/huISxXyN4gNVBJFUjZ5QL3a+9pYTuXqO2X/rW
lClfuraJc7+1JuVzkwzjuEsKx/rsjqP6xRvGIsRjTC8dvnhhmWyrkNWaOA794Kn+4dGPpPGaqtAm
yzSZa9b/8N0ps+GtMk1kMvNAZxuWVFH82RTV4AVzpqeJj7eK9mHsiqc5bJr+ONnLLDWMslDzBw/6
EIZxZL2u1RRBnk80w7M4an90A3XbYMwX905E+H0gOlmzbRxkEz7GfWY9UNObR38uvVrbUXUoDo7k
C6IFTmtk3xKWXBc5b7vTuk4603dTX+wqkYGgoBgvqp1uNbTYFK3LBO1310RM02wgy3hm3kQcPeTb
+2rKnftGHTT0wh0LBpI30TwMyiGZJn8BIWzc6lh17+pCVX8Uetg/lo1pL3trjL3cd03Q0hgpLr12
nOgZfTLTtGwDvbS0DxaLUDzYUtERCwSr58Kn8OVHHRi5oNHnSQ1yAAtilwwsXX8041TnF46UqRI+
gbazoij6jryAea92mTWii64bCudmBlQH9K1a+26lVNHBHJAPPbi9kW0RtdaVI7CTIOEQ+5K2RQb5
5GlAaxtRtyxWN+7DRWj7UA89X8P/eaM+dVbslcPQqpVROoH4WQNDb9S4R49+3E9kbh2up41iB2rH
ZiDdTO/jVG0CG+vtb0Sf1q22lC4gzG7ZskKVb3N6v0JFhUIoUwKo+mtEVNzSbK9to97bVaHduH06
fLVE2n6qk9IkqPhXCHIhvpZFidOh0I8jBqXvjgcD1fvTiUUX1tPaPBH7vOrBhAPvwgYq00a+MkU6
V7trqFp4u7jQaxRhVP4TtEghqvv/Hx2u806ZCf7r08i09jTv7L8DIvlHAiuzVPm3/5ltmn+wLkH5
PUvDQ1N4kW2afwDp14FMuageAlHn+/6VberGH3Qp6UWB7uD/B9zx3/Gg9wcXDjBbWgkALRAo/YVw
cL01qRujeYN0Jdh/hrFW1Zmq7roMi/Th2LbAmhpDi3ZJrG9tzfWWkKNQ7Xx2GkAUds0vE0rlyNLs
cFTEYPgTzXIUMuJ0lyjGlqnB1lDM9suCOMw+bj+tGI480Q+rQy00dEMzQG9R3WiYrTcfL4VcpBT8
BIJC1241kuuOuZnren+sKgUpB2TI7ophbDEH514+Dp4njkWrtgAVtfbr6DXGBgzpwqejbU9igHeD
lK5cfTpNb0KpfN7TedBtsBEettehUW2cqhfmk/Rd0oZoorGGV3XRVsStFkopSE0oyu2S1slNVOjc
H92vM2yZULr/rEPwNtLc7fTTaWPh4glU9sd2GtyjY0jWXuxt4ZQuTBuoLRYjsnGedaYAUhq9iFwn
7I66GnqEqZ3zgcbdFsvj0ihUccjauPioF60WR+/QPsiF2R2F25m3czWF+HC1W5ow6/4YS5Dvgl4R
5wPEi7VXcNXprtQC6I6RXjbXtWbSxKCLfQ1g3LnBX94JkAHzdkWibombX3o/Fwtkm1NNFqrksnnR
d1JThQp02XXHvqfEiRSC2I8UwPcvDtEL99v54gPxRGeLljQPC+jodBRnUZFILnRxLEOtClC9xn92
SuwAabDmFxtp1Pw5apGe5Zuxo9cihiHEV7UVkzjWWuHcLHrvXBeV3TzUjlVe//pbOTSCiUJMlB3W
wPOuHGJzKRIQlHQ+dyUU5KBS9PSgLLryj4rwSUH4ZS3x/DOhdPNiKK6ll5/JqLGC74qcobrWuKrM
zLqdomLrhbZGWZ1Ew6D0AvPg6liwwRFcMTXw/lF29W9MmwRnS4AQUK3VSZQU6VzUUcS7ELlfWbFO
kKNYyS5Vi2T3+lAXX+i/h1qfREMYd2ELduAY0nK8RuWJ9m6iP70+yKXF7bwYRNZOX2whu4e2ARG/
OooUvDx8IgeVM0UDyjh0/utDyc/8Mk6UixvaJ3pjVKUoeq9qmWishnOoutUxba3mGHVQ6xMVx7DE
LX5wGuYbX+ri9FHOkgVsVNTWwq1xpCwp/NLqmDuJclAkdyRTnOyXP5IEgJLuEUCZ8gw6nb96UJwS
qY7ySNfocz8N2V545nh4febOPhItdYI32t50v4H8rAapulRPwk7Nj52LO7qN8tBPA1c5dBMaKg2v
j3U2bc9jPWP1pPzcmurJbRVWRIo5nWl7egwjCrqUqJNqY5gzaAO3OfqZsGUJPOnmr4l6FXDIIi67
/Ki6Wfyg2F4CD7/FBCvDrHtpyv6NZsfTvWKM9Z00CH2TkX586alepYGmuPTbjHi5d3olJuCY0ltu
gPZDCVl6g7l5tmrlczLpkmCLYu5ajiZEc8xKuiQ/9lHvfWu60HrQ7Ko+KpHp7FQUyX/1sIT7SqWf
pQSLUVI0TxeUiRp02UZOftQ15fOs4lyR00L81VXLIDDM0cuFrY/A4CowyBb4i5la58cszBsqEfWw
R96+35i6c50YyeOFt4j4nuT6rwWecnS/VKVXsiMm2/GjyGNj3tmKUdJcNl0aqW0qhkAgZhGUSzH9
3TBi71ijJvuRk1z3Y70VH1wt0u/GuXbuCoOJ8GtlGDO/GNqFOhGVglFUWoWFyiDe/eo+AO4M9ldi
cgk911GNDvsY/XUT0Ew+u+h+AnJu8GzZ2NlnsROCqxJSCAkLxDq49dOvTQFM7V169MewEeHXWSDd
Vo1zdJgHO7lthqa5C8f5yUGE7MPrr/ccG52cxnJk8nV2uoqu9To2NIRTQt/p0qMTx+mEuntqfLCW
2XqsRDMnwdg7Dp5ltjG9m1M1q3a1mGuMY5CGXe6Ei1imH3at9y0DOvotim1qZJmFD8iWodr59iO3
IL6jcEMH/8ziA3aLNk4gC47QQwxYruk3Ky4Nv+yKOZgXitSvT8ul7wHwR5WalGQba1JFLvuVjbqk
RxiaRoC5DW5OMvUI7C4Jj3YmzG99ltlHMdvlp9eHPj94wUZ7MhQjVgfVbpwuhVhv0rmN+/Q4hXa1
7+LODnAyz46vj3IGGlCx2YMzgsAEVA3pFnE6DBrj9pg0eXqs06Yp/VxFy98eigkx18m8cWiU3syz
Fn9a6PIFFVaF12M9hDQZym66RkXU+9VrWj6PzOkseVaAkDx9ngTRca0SdnJsCzVj8aNS39DC2fiu
FyYX5DOmGNQquK7XaP6GGu7SI3N37GNl2tPMFnstBcz/+uRujbL6hFoSzkB4GGWcnWKfcZ/7eplt
GvGchwPP0HRqJWADOcDlz1/EbCHNX7efzfg4D8Ubt1SND3ESNXhbxuCD/NhBJjcQ9WwizaTYyce8
ouJmVnoVH1yoOtcJes0l/9PTf+psqj/F5CTuL18wPKKL3KqE24AkXl0wXZUoWhS68THtEVstFnd5
a+ZGun99vi9NhI2IvdQYlyn7apSsXuj14Ox2TLJivLG8Gn8rr4/3RO7DxqeV22J1XHJGIvIBhlYe
Dquh4jFvoch28ZHqyp9T6rxpqWv7eed8EiI8ABL8/vqrnfN+qA5QUsEBhzIuShVyrb34yLGrDUsz
lfFR6ersWGAdHPlJGHW7mhT+jaYt41Fp7O52SpGXXKyoBAhrxG/5lNaX1x/lfJalkgoAFXi84FDX
ikkIqauoDycxEWG+fLTdVNvFUhLPgGK7cRicn/anQ60Op2oxujgdGEonrD5gE5ZdWSgt047woju7
R0Pz9VfbGk9eBy8mWTPbQa1DxqPVmx3sShg/kyybAuA6CHTCENm47mXwdrqK+KoytrNdIDWgzk/H
S4l1Ok+t4qMRh9pVnalm7icOCCvsvAftXgFhGIwOTj1h2Llf8zTU/nz9hS8tK6YYiih3DRr2a8+7
2KCj1Gqs46jW63cNxKnPDoiooA9D43bkK+9rp8iP+WxmN15Uh/vejb3MF8Ovlh84jmltAjJ4rk+t
tV7iqXK8KG/i4zRq1PHYdkE/9A3dN9Dcr7/zpfVL/YvGhCyUUnA7nfRwGhotqqL4iPxVFiwoifvZ
PLtBrostmcxL6wlaLkoFBvuFAuLpUF2VIkyeO9Gxpll6Y8TTuC8axHLSOVH8Oc7TjfV0fuFQcpU4
MfBgkpm+Gi8bGjg8iREdsyWubstm0P5UnXKL2np+9jEKMQNVZp1XW1MQ6ykVXYun7lGtwuGLgBou
6WXaQXeGOJjIy3bYlm6VfC++GiuU4MCCbLMmLETUGgk1y+gIclF8WOjsv4s1Y9w4AC6EQ2hswjeG
8iXVAZ/3y4sTQFHcacqVFJBJbhbvsiWbf0QcCzeA1cIHfaydm3Z24r1Z6oL6WFoGQ+lMb4HcFL5T
lVtiL+c6buwKeobwDmUZmsrc6QKK64UDJC2YasOr3mREcJ/LeFG4QVtAAWlmvFfd0mp8azbqpyrV
jL1azOYVVsbpvdCj6Noos3jr7rv0KWjvkaqjdCnrracPVajaqCRKHR3BIRtPMMSGoLAHSGuv79Oz
1qkkp3EkIQVPMEhxYDXOPBpza3dxdOxZD98rXXj7vIHK4BWLdSt6cMOz18TXXgSFXxRCvFumedqK
FC8/BYgp+IqIlVFvOX1b1oLXh46CjO6cLn8vx8YMYLP0uy7O26DuO5cSsJftAMGkD1j6ln6ReNXf
X5+KCzNOyeGZNEk9HZLr6TMMDkcWMGPlUOAW+w7ZKAuEU9ZsLH75W1a3EQ08Sdjh6JCG0aejyG0X
2+WoHKKl+6x0U3ufxMWhrK2J88vbSDgvDcb2gmxFBuLCnD4dzIB5vmRDpxymNIMoQrK3J56w8AUp
3VtO/S1DtUtTKMkC6Eub0LON1VUbeykaLnnPyxkeBGEtGwMlcbINL6WLo9A5RQRKyo88ize9OD76
Eg0tu2+Ug9NXuS+Qrzyk4bRVrrlwAMMJJP2FHMD+WMsc0uSIl6ZmlKGx0rfR7BZ7r5V7X41a9Nrr
8RZkdbLxavLrr1fHy0FX+yDCdaZHokg5ACEz7zsxdrf/l7Tz3JEbSdf0DR0C9OYvmUmWkUoltaQ2
fwiZFr03QfLq94nCAqtk5hZRfTCYQY8a3ZERDPOZ13Tj6kXz0JjfHUPEd4PrzlHcxkfqqDcWFWKX
lBMA+geAZFcCK2qFek6WKKGXpGakztz629xu0etn7EZYwGaU8idIsXLc5d//7dNlksFoYdkQapVd
Bku/JYHVeLrfZNoRjPfGhHjHqOAiCoI01T4bmuNeK0XaeyEIKveLK7rtsUer/yCkujajguPLwhGr
y1yIv7yckT42ar+h3xraPdRqeBZpddbiHEXAbFF/GJqowy1Xs5927pZbsKCU8ANNCO1J39Qicuxi
Pq28uc/DZCiJj3WF5DJxEQYA3dr3aW25J0wlxYGspnbjYkA6GZ8g9FhlJreLYVSSmtiJMy+0irJ9
MksxxNGmGb2b+W4FzeIuV6YUeVxHXT9l5WbOvqem2Y9CaYpPemHFz+nq6Jk/4jKOVSifvPVttF3r
YBXJlDy/edPI0FlWoyj308u4XOKu8CZb0Sbsr+daO3utB4xMKOXZ6eEG/a+G2rcdVQGvph+ln/eQ
LR94JoZ7XV/E+27Z4oNvcOMo/D6rfRNjnUUcOw0e1Smmpp8RblPvHHon77p0Ev9lVnirQvMFr4A3
w+UCTk2R5B7d4XBSQdedjDZPp6DANPpT7Fb2+fUlvHHupA4aX4rrWUqpXw6mUPGZl7XHVckat0BJ
3e3sCTTJ/ssogKKBt6NCtbdfKRl+zXv2BJV7QMD1oPhtWh+JY8qdtbuOmcv/G2W38wrX2tSl7HAE
nrvuKw7pdL1jxXxnU3z180pBCRDlfCtQJ0yofduG6/Qfpkn8h+CQvJP3MYlwSi02VTzZlb5SfBUd
Nh9EoxX8h1HwYIHdCYzO2VuFbJtXaFnRsuvBWUb8v5QVrZKDyOfmxiAugA7mvgigXW4Md80xIKxq
TMJV71e6dAnOL9180P64eapIsmX3gyRtT/ueKOCQa7LVs24yn9JUKb+iAGpFQxsflduOhtq91U2P
J1dic4C7Yqwe8UDyotEUW5AvQN9f/0C3hgKjIB/OF5mm3VC6PYMVxYUknNUELb0xHx6Wtc5Onhid
/3B86UwQA4CKIEXbNUcGGm7UNTm+Dfx6oremPxNx6AfH90ZwhfCUjVo1WRtYtt2NFNcDQmtzzmcS
s/XQrVn2UIJUu0PpyfAz3e0f5zpt/3x9FW8OStsTSBN0eQDhlxtwRuiqngvs1/JZtGfZ/Tp7SOM/
NuO4faBkPNJmMLKDa/7WS4tCMIg9mLSw83fxftt7zuyu7Po2L+ynSggj1F2lPVvQr947qVG+/cZA
0UuW9qnsS4ribpKFtbUqCNAQqd36NGVjc7IacWSTeGMpqYHjmQ1yEGDB3t/FNOCwqjOjwDydzyJR
3VNNPnHCo117VLNO9ztvOnqcb9XR6NVQdUZ2XWo77PZm0y7w3Wc82tqGgmXQKfrwUU+yugntqQbJ
XnJHmq1RPycDNrUtqHSUJNEOe2ytTT+wO7pxJMGQoZsBGJOQeX9nGioybauOkZvXxBlSV1MfqGrc
hZB5/ssnRVQbmiFgP3RCdi+qCTazL3AGC1uIcR9nvD98M5ndg0j2xvVMuY6QHGkCKN97tq6tNEId
qEWHo8P2nNS8OmXTkL79qUHRgeoScRyVyH3vNQEyn8c5o7QQKsPcmb5t2CxErx/0W1OBkG+SydDM
p9F1eQbwI1bbssIwLRvy7Wys6OD32KT9h6lQn+c/IBRIneUZ+S2Xcb1Nz8oSmzTD6/Gr17GWEm46
HXyWW/sMEAp0MukbSLv6chQcBsreTgfIQ8Pq3gkl0R5iJa0+wjHr3/7KcOnzxEinOYvTfTnUhtIg
SpP4DfVObZ/sxM7OCslHWKeqefCFbs0KMq00kwbnwUa4HKpItdnZFlybACq0UMbG6q7VnOqE0MdR
DHfz1qBYQ+TBZUU4tzs+mpZDtwPdEWq9dZ8VCqTzRjlTm/7LUUYYHYnzpfbwqelqleti0P8RY/f9
9Q15c7qAS9goJrDJfawfiywuClqAoc5FhW2xSzGvMOtz33ni4CPeCFll+APFGZ4h3NvdI2ct7lhU
Ki7kQ6srj0lj6acW6nDQxJr23sp0dG9E3Z0hPs8f3W44kq27dfR4WnGtIuuWiqqXHzbxxgLdAkxs
Src0fQefrAC21RFi4PqbSiU67l75oprIE+0C80bx6jWbO0yksDOD6J/FtQ873fmpIDz4aG2whVp0
Ac99kzdfJmHOYVZPw7OZbwhzvP5tr2bMT+HSBCEDaEmKoF/OeOs0fUEo2A5HV60eTTsrH+xZ/fP1
Qa6Y4YAxUJ1EpBZreaoM+36gaBescoCzhyYidOt56yatQxdDUrDUeVpCpEPWn7FREEh1SC8vFBFQ
yV69rXV8x0jLHnpQpi2nUTTVEs2j6s3RbA31L8TfCkREFiev/D5u50d1KjskN9C1mP9Yel394gx0
686zJhrMQi1trn0FcMrBNScvy98zLejWdALk606LjBdiF+EmKKu0bjfPEZrCzfuBRCGoazcz2a2b
etfOY/dFzXXl39eXdX8uX0alNuQBOwFft0dHtki0V7oGB8Luu+GcFyV0akhlft0Pw/n1oeQ9vZsg
PWypWumCyeLRuNwmEC1iy+WtAwJSYQlp6unztplOgKaj8py2Ujwfkdlv4+YWB2yF/dJSDCVccog+
uW55FeXf/+2d8lIltfR6m4EFmOsvyrE/NxWf2apPurvCdpO7ZRuWb6/Pdr+wL2NScJb6Hwy8l21L
HVi8+sznhCinn7ZkQcIxbdwAVN168AzvA2wKbyYyUTTJkVJDG3R3FVhuriRGbXdRzDOK04O00G1U
zj9AR1+xa+9gOfcXrByPCj5bVbq3UMe/XE4dPfNqnqcuWmpjwPxD3+7nJO8Wf8qK5aylIvfpnNv3
KP/bj3TWMRJ+fW33F87LD6C2gtsArUFqSJc/oPPy0o3tsovWcXDQfeGB8yt1geP8+jjX+4bXg34E
MjASLbd3UXInVBu5edvIc7OkDtpan38s9iyZBk2d3bvaZJwq4KPR68Nebx2GpdwuSVA823tyjRlL
x3k6MVExl/9g85nDAu4+b5pzRE26sY5UieBZURmTMsK7D2m0rlA6bW0iVDes+6pDTmZNlPXuzdOx
wEFLozqyMZD/l18L7rZqt3PfRNAFxZ/CiJV7Yu/6pNZKcaSfdD0j2GQI2zMf2BOA2nZjaUXvxfB4
o1RB0MN0Bs0HA1meXp/R9YEDqiedtYiuKazve3Vqs6oZ9YMq6pIJISJtNAOkUSJhakkwKPGROuWt
SZH5UOgj5SOW3233Je9b6OZZHSmSLgxWCHJ2sRwhgG9MipxV6uwanCxu6auly7cqtZposgv0CDcj
yAvzbhir3Beo/B4s4Y058ZFRoNHxi5A8rsvRkNRxLCKzJuoXdftojM0aCk99K5pWJliGBLlKxQkK
/fJX/HbxmzF6vVqnNRH6Z+Y7gZjKV6NRj3yYrs8ro1AMkE47BCfq7uUu1xrNzNGEYbCpcQjxieo8
xjPRUhlHojK3lo3eIrgzMiHIxLsJ5arVFYWiNtGMPB9s5jajPT8dCcXeGoXdDW5FJyGGUXy5bAr1
a6tcStgZQmgBAgQjPAPlqN92a8Oh6gHGljDZA5t0OYq3oOpSt14diaJz/0rXQTtPq2efCw8lut7p
4oMA69asXuhovBqU5fcQ1HLSqqLTtzqa8MsNXQcxjArb1ze/TXiiUz0gVsWFGZrB5ayWqcW/UJR1
1AApOtdDCVzfbpyDUW5sOfpA8CTgB/AYe7svZGDi1Gv4CUepmHFGMevqvLFs4EzHN+uzcohIHKU8
K6BHqgm7GbXlmFVKzitBcXb03dwFm2z8SYv2OyoJv6pyfkyn+o9m9R7brD/oBt/4ZvLpAKjL4JKH
ebmaoo9LQXGhibwpWYNcm1uApvXRFG+tJkUwSMgkx6ht7i5YnWtxiM2GUZoBHPDIBYs/18fM7Y+u
vevQibo/jqDkSy+mXLuRvK2zFTgQTQT6PA3jbrJ8dzCmKC6H/MnYEj1ogHXcgfZMPnWleWRKfWs5
aeXT6ICbKRUDLpcTJq/TdlPWRE7jrQhx6FZID/StHg5yw1BAk74KtKauULgEGpVqzZCT0tEanvNN
AdudYctLJlMYlV8X6nxwHK4DNUakugxLErYXadTlvAqtqhWk4uuoHNbukfyQ7C9pzPe9hrsOEhST
7oMr6I6sfq9AO3KmuKYQc7NtSJ5229NakqFW4pQrbNnoS02Z8iXp6+LB7XXzB35HmT9NqfE8ZnX/
oBMpfkUd5qgPeGPu2BpIFAjBIm1Hec3+9sZlZiW0SfWqSBs95SFf8vK9qVLuHixUiZpcn98DBHgr
tICJA82TrwPavlzfuzsBnvvYC8SFox7A2B02hGiOKMl4EDne2K4WMb7kJEHR5z3aTY3b2rUqvYpU
bHQ/bmmLNiKVhfPr0dw+L5Vz4SOiOyiNQMADXI6C6XA91aWoohgZmw/N1uofoKmidotg/QmPYOHn
Xaqg1oQe0usj37h3pMauRFwb5MV7iOhYTXpu9F0VVS3eCiqJEvqt2PtsunqkcH0F8XuZJYkTpx+a
CcHQ5Sz5UzBDoq0ixbZ/aG39zlLG92PmnfKyf9bH+c4WlUdE4d53iOwUSn7ujOSub5s/X5/zjW9K
WZqYmUIkkIZ9+Vuvu6QeebSiaeq5AVGL88ei2N6+c6D+ku3LTArU8+6eNXIYQ2WylVFnasiaFoYV
JvZwBPG9EcGwmGQcEtpMAXy3purSd1LHp4zMqdn8ui6VewWoGTp1iY+R8ltb4XxCSZ5jpxJdEMTs
InQjXrRpbB200PsWn5+u7v82Z7EdtHVu3Ccyg4KswouLRtTujaicRGSGVhSR5RXLP+miD+d1m3u/
WXLvoexm7SGfE+2I/3mlwC8nx8xQt0UDgahwd42lmye1xYw8AobaCHztijKqYOncOaU9RnmeoKBT
rfrHTau0EzwEWs1KX4ZiMOnRWm4ZJO1mYKzcOQchyBVWl1/GU0avV6bdss9xeXJWBaMI0K1F1BjN
jDhX7PhFisYTcJ13rpk/xXGWhbqafHDS6l1ei6eqc3U/t5afbz454DwoEhJdEjXvcVZ5X5uz1cFJ
U+xRe5gGr8MkaZoPbsMb51MmmTZ9PfYAb+nlbKkzLpNVK3lkdmIABW33D/Fo/Xh9KjcuPkiM8lNL
TW0QapeDDHXptuZq51EMwu60pOkWeAO8qMmbDka6cUTp57CRaVFyeF7K6L+9jsYC5HbL1zxC4g99
64z7bXASvh6R//bnlhRHyeBVYZ7tAkVKA3ohUYTMcj83UZRzBtPN3fBGsowFZc8qUTLEvRIrar2l
PClL1p+G0vX8ZV3Tx35tUOSys+pg5976lCjlSA4xuopUyi5/iYyUFi2u0A5T5/68NZUSKAAq3yge
IecrzY9AvNJwB6NzOYrrpEmZNmoO2xYhranCd9sDSXNCGlQ9uJquJ/RSvaVsgA8m9cfdBaiuqYla
XlVF8K6UezNevg/CVO8P9qbMnX6vUxPSoF4Js55Xmc72fkJ1FxveVKdV1NaoegRibbPuo0kgt57h
lsVDUAtUSM9FuriJL+Z26HzeU/2DRNGDi0Vl7ju133IOBtDiOgUhumGn1Fz6j+pQIDhYpE373Wqc
5GeB+wrMW6WKx8fNHqb15BGr2kEFxP4nuv7ZZ4F44j0azut5VvX+Q5GL3vAVzRhwaSz7uoqEs24J
nCgsde4UbsCv6jiIJhqstQ8YGBv2WDP+6QyAJqgQGNW5tTv1W4bpw7/KaqrryRkFqrNu76Hw2Cmr
dh7LKb4zFWvrzmisV5s/Fw6ITR1det+seyc7uHBuBNGsN3kXV4GE3+6rrKva5fmoG7DC83b7c+49
++8ut5TA1ZT+Y1ul2nsN7Ube715/cGqcKjW3eGs39uWbc82DUoERTbHuchOTf5Y6Ris8OfaWhIs+
S9s3a/BH0znKVW5tYrmx6GYxINZWl0NNAvfhwUPpQO+Q1m1WXHTJMt6e6XlU6WmaI2gA8Wvv1ue1
hoXuYV9GaREbd1Yl5qcSOt3B2b81F4JJqLRShYkO/eVczKRgSTcBcattPuOHmkRxXCkH7YbrxwKx
mN8G2S1Yqq9ZWqwMUmQINA65W0RtZqcBjfMjYtPNocgipZ8E+fn+8auTbWqcfi6jOVGRGbS7OIwB
qfrTso4Hs7p+mJgVkN6Xgi4dit21uYHSWZEv5gNhP/6ABYMOh7apEDTEjzz1y3o5IrpcB3aMyJtO
NUfmU/vwMY/7zOtzRrS6wXjvUPIPrFWgluk2CGciyBLOufH2QhWDSrlfqpVgXfZhXVHkFDK9tIzs
ORMPc2NgLAEpg0f40KfhxmaEVMKGJ5mjPbyvyruLmLe69opozSrxvqx0+1vROUjmvv4+3BoGbSJ4
W4wDUWz3CDlDBS6wNxjG0sWTPjTD32OdVAev0I2PxYkiiiC5gC65xyKRVRD/Qx+J8qZMgrTttHsk
trUlgEqtvRdzZp/m3nEPoHo3R7V4zMmYAPPvY3+YkJO9dmsRJTDSws40ukAbl/zJjgs1bBJ8O+zN
s6L/sKCYJiJ4gbARtMLLSwRjCl1WpYpobLX5LvPG2O+c7K2iZNzwGj0oKqZgQnjUd7cIS2lqQzMW
kdi65N3SxmXlN9bcHNyI8tjugoeLYeTu+S3eXMfUNhcE9yJrdPN7mzjX8Zex+oGWTBHiWm1HZe5B
blir1H0wxtg82J03viB+T/SAQeWR/O6BXwMmtHHaxXm01eb4NCPsFSxmgvf5POmneTD7e6Wqkq+v
f8EbKRItRAqnlINQECOgv5x1hpxz3nYd+hXWnHVnHhrvKUNzmFR4MH4J1+1/zL3qPBJWzRhe5Mtd
qih6ZMNsfK/i7HKwo25c43QAQcYgEEx0ukf7V9yd+qK0eQSdXQTwLMtzvWoI0KZGenBOb9wG6BBK
NRM2L9Dc3W1QufGqlwtJGVHF6OdpV5zrfDqKkW5NyJHFKZOAVKIHL9cXv49ejWFbRnGRwuLe0G2t
1dzFok0ctQFvTkh2a4l/SV72qZnTqLHWWQyVdt4/ie3WD2qWHpG8bu1SUBGQiHkDAWrtDuO0pBBd
XD2PDBeJ5nzplnNbr8k7M12VIE1s+x6851Fmdmtm0lGToIh50Qm6XMQ8rprJY9kQFIiFjz68+LTM
Tffl9bNw412nF8gj+1IhRfd3Nwo7wtQrEk7HysSHAgvN5zqP0TSZam8MxtiwDm6cW9PyYK9KgXws
0PZ4s3zt2nFOegonWuNGlmIOobKqR2qEt6J0MkkEzVg6oLj76kOpqNVsFnMeeeUsHtRULPei0rBJ
bKfiOUmgaRPIlPcgybNvw7BRb8O16f+avPx/Jf1unAOWFl01VLEog+zF1YZ8AOW8Jdwz7mZ+9RR0
szsVsYo+no9oFDeWlcNm0a1h0tL1+vI7TmISi1utWVQ3av3Ny0x25+DVp9d3y61RiMbonBnw3DF8
vRwl1wXY7bVAIEbR/ukqUJkGxoNvvw6B6kgrD/a+dFrYDYLiYlLUaRYtRaIElPXQ5kbt3K90zIZe
n8+tDwQUHKy/RN9f8WiqTdTYRjlppKXK312yxKdM6M8KpuvBfxiIbc8Q0prtqpztGe28OojRNI6d
BM06qGdsotBVj9/MByFygLLzUnqjGX6lwYJzrI6YAt4zq9lR/+vBr5pK4p5fn9CNwAHBKcqtWB5L
ex55Zf4WOOS9NVc6eL+IJiBSEbAm4ix0MLwcznzT5SxW21mDGPTL5osScgfJuGIdcIeuLi9yHyof
sq0jebD73FTiR8dk4HwhnNl8yOZ8CGaQuz6RonOqqjp+a5lejgfSXpZWJfdqdyV7o9Yjc1XnEZSG
KvRUMfmuOSYH+//qkBFAEpSgpSrR45ROL5fWtFHSJeHOIs0TPzplmk+q1scHgdcLq+8i8pOjSO0E
WaQHeiTbTL99QJoBlJCzLosUaglYC2QDgBAFibsSVfRPbuYVCNnn8Uk3eyVycm3KcAbQq/eOjrRg
Mgz4gXnajFPmkAx+2aH02htiOS8gCXFGVZRTn6VWkHbTpgSO0a3PyprZB4Hc1fGVc8B1jv4M+RpN
qcs5VKhJ9vrISuHwMQynrqtNomTXLjN/IaA9uCz0q86bBj2ZA0U/3KFjvGezmJlZ5ODdUWPRdXQd
krXLz25MifRBpXYSPwyORNyW/QKvIF66n/22Jk9eIxrUalasMNxYcx8gatc/U9tQombVl8ofEqt5
n9XO/JQWZnKepjh732zCAdI61f6MYGBQG5t5P+KxGNWz2t9VwjTuu1j5BqT6iEN/vfeYInIOcCih
XHHLX65opqm1BiwCAaemtJ7WYsj9wmyzg3P0wja63HyoqxF3SBcu1nNf7rFzI9HKfEqjWM88f9r0
UG31T2k3gnr3vg6T/mg68TPqe6VvVmZIVnyPg8OMi3ofpPX6vNTz53imsyFUofq96MOunAx/RaKn
MZaD0sf1msiKlCSmEGCCOtydFBjfnmLSaQzNel5nv27MCmf5aVIO9tf1bcY4MgEAPSLNEXZPeFIg
k4FogRtW8Wb8gbVE/b2h7F/RqC+rTxtV3IMBb01McjrobAIF47+XH7sYnKWfeBrC2JuVey8n7zKW
tHxrwAdoTkIdJKdOto53W8ryMtiINDvgN/TiHufN7CTV9f7LXACKEKDLasCeB24bDe4QFXPJxzV9
n6id8NuqyA7Sp+sLhyALMLFMG6Ujk/yEv12aqas3cyGghYxd251snBpmt/m3Bp1yMJ0be0FGc6Dz
EDajXLnLOEZsOJp0cO2wTpL1UXQlKbjhkHvMlvjSrfbRub89Hm+NBB8C/969bJlpjVVHlBVWUHv+
ERPimng8r/6I2OZZNJr19fXw4cbWkyw80Ki82/DOd2dqK3AxQsvLDl191B/j1MrP1IyW8PVRbn4u
QiFAojDXkAu//FwQ9j0ky+SsDKBDKYCUu8FYF3SB7CMS/a0F5C3i4pQwN7BKl0MZq4vcoLHBb6H6
+7BtnfFhXuh3bO+sPm8PtuH16knJQKR/6Kxzie4FrcbMahojzowQTxnbT/ueDyUU4/zW1ZNtOFqq
FEN57F6ew982e4NP9cIweojV1PfNLrTAok4b9vBNDup4t+YD+sEkOiYpBCJ/uXhjN5fcCLoe9p5S
gpK3plOVlPGbLyLmA/KVnjSfieftcpTVSFSRJIZOGzrP/ayYtC/KoE2f37xqgJGBp1MbxGxij1nz
kJ1Mm1joIe6JcYj+TBbmraX+MWBvdTDUjWXj7ZTkWvAHGm5zlxPaTASQG3fRibu7+2E2rcepco7E
/24OwscB4Y/XJX2Ny0GWLlaRJWYQu6xXqv34OmdCOeoyXZfkZNTBjib0kLCKfVW1nkt0XatKw3m9
7j/36Qgmhct+TD/izzrnz1osBtzk1LaApBbXreq3cKqT+2YbNsSlNqQ+z5tt4Xj8+ue8nj5R0As2
EDSnJB9cTl9NqlFkECtCM7GLf0sQl/T/1e6gU3x9e1A2V6lkS+4rbf9dWc6r1moorVplkemvue6K
tHxSvpvTrg2squwPTvbN4eBy0plGzwpM4G5SOJOl4FbUkAOz3detqYeZjR5TMlepv+ABfHAPXy2i
JOAQAMjWuxQYkff0bzfJHGcm7nemFZqzjUkePrxndTPfDG9iFDCivMqkZlANd7cIxu6Izk24uOOp
/dOcRyfoh9VENmD8oShWdZB73poTRQpSAduQZZfd4VvaLB+6XrXCpTXLAOX59px4Rnlw0199Kbnn
eCPJsmk2XAHoO2iKWauYZuildhItHl0Ac97E/dA6YEbN9Eh680pw/oV163J7gUKRYhK7nZhNtG0m
NFLDvIvpJLbbPMZ4hgxlH2ydCRzANNs2pTSto+k+bKVu+V2fiK8YcFj5Cbm5pg2MWdenwE3FqOF2
pSkGD0fXjFjQjyCyS9GuR00ueXVf5BO0DkhcALLDBqE5v9vQU04kha2fGfZJufxZA7o4r7Vin4wW
HhtaSe67BdjAQQp9fWe9jIqyMBUQySTdPSjT4m6qk5CfCHvp/ym8VTl7iHw8uqWLJ26HZQT2l43A
1a1VatbAdkMKgc2T2eTx99mwp7s33lX8Hp5PCfCFvaTuke8J+g6zmcPS9+rUfFpRDvLVch3e+owy
CiKhiJtQV5V+JZeHmXLZiKXMiCrGaK7vTNHaVLEc/e3HC4gF7wFudDiS7+v6vaFniH4UZrhivBFY
M6rXk8kOe33Fbu0bJBQAKZLaw4zaXUx6rRaOIVwjxMyhiYPKLZeT5sGS8nt77e9Iicx7KnpHRL0b
dwdfCNgGJl5wpPbs8qVwVq00iN8UGok+YATYuqPXHyzhjclhakdZTLIE5MV7+aFEbU5qN6l6aEo1
b09jnDMCa9opFrznfsaliNO0PX59fU3lNbs7i0gfsENAJRFR78X+7LU00dhcCRi0JfGndSk/52Jx
zlq7upS04glP9Vj9GLvrr9cHlh/remDZLIH6IZU4L+fbaQ5a5dw9RMXTcB7nanoq0KO/XydbOzhp
19UzCkAIA8gMhjsH6YrLsQrcT9tpWrWwzlRI1n3algGqawOzXlqlOMWU3H6kZm6dgGu7Z5rU09nO
ndwMzK0Zz8jI9Q9gN7ZTvrZ9uHLlPpRJitUL9r0+nixt6E1N9thxQPx01atgyrR2OChK39iG9FwB
6HJn0Lzf0808BLlUPo0WelZv3ylLkQcxPZODM3ZzFORDdEaQJJLdUg2VqVJAGbVQsfsPPYapz2Oc
awebTv5Ldt+e11He/IzAM7B7+5uBWuaiTlqYKRsXbjZ/99pKR2Fsvl8H0vTXd9rNKREOOjQEKQTs
QeF1ZqRTPLRaOOJ74quj4dwXG35Ur4/y4gq3nxTVdR5jrkFK+btJ1VgB9eXSqqFaW7UVwIzu/8ZH
jIoghRD3u1JU6dcmxY01WAyk2yglLmIIy5kapZ/kkwol0tWGX52xxK3fo/L5r+EM2zcRYyjqL5im
m2eoEH0WKL1plUEPxDqL0O7j3Soxgm7R1/bsb1bV4ktpGitSZvwPpNvG0OaM+Ds2ah8f5/qfSsTu
T4+m3r8a6e/n2XTFl2VUMhPEjmH+jVNDsfiwu60/zWSAOgD9ZdR8FbYewFbdBb1Wmom6YAQ92J/c
YlZdpIII4M7wOps/ykwUfyd9tySBYVaYDM9qgy+v1rpLLcky5ejzw1fr/D9u4zipO9RaOMdlbvt2
Aj7YVxu3/n7waa62GxR2CqXoYMEzozN8efxtjFVmVy/XcKXSxCs/TsgpNu5A5cQ6YntdbzYZZkgq
sknf/uolxAhUEVrermHWzH2QTKb3IRVp+fOtMwIYy2tBBY3IAZ745Yw86bYMkksNyTOds76Urb8o
WYvD1XIkRXXN7SAtpvALB0HKJeMfcjmWak19MWzdFqZkdl1AErvdU4OoCSSqKuvvlz6fFeQO03w6
lVNif8U9pf2uN6J6nLI6noK1FJR8zaJufrx5FaRSFd0kRJs4ersTtyxdmzeQsACfdnqAQTEhJKGQ
r7fdUTfh+rUi8JBOJgCG+LZ72S9u88TrrXQL+1jDBhfycqiorgAAOR8t+HUgwFCyGsGzLNHVu5h+
UkdldBtrRTs0JonWurj9qG3mCkDWTJTnubDwEUpWAzGu15fzeutSZlFpwtNdpbC4D+Ks0SrTGMP4
cBXe9lA08S/PEupRmPPCW7m8JxmG7joKzfBM4E5f7qd2q8d+0bwhjBtR4IrujUTilaltxRk76eUf
0+oAQ6tNYjS+PXr21zlzczzMO2EDJe6GOD6lmEJrp9mqMGRGuVcx/Ww0OkzoNaGlmBS3ln4mklnM
c2ot3efF25o0EDit5wCuUZi4w/uQAlxXeUsXJuUAs95CSPlcl/Fq3G0ibYtgGagd+zxhaLtgepAn
QRZTxXtqqwonl3UrnTyoLD35q1tnVwlad07dk1e37jswdYl5Zycd0Finbzy/LYT+WZ2mLvEx+FYI
qeI8mc+z3VfFOU6q7KMNJLqifZTgt/2iTH+KJzVRfUNfXMNHRKX/t+21uDwZ2mq3fhHr1V+d3Zef
4R2UH2c3sX928aT8AcJOLfCTarU/nE7T/pyMyYVc1tZGFWBE1tV+NzSWDchZF+/NUtNBP1uL96Ge
+ib2vcLJrWBdG2cJh7QrEWN2lK15VyF5RI94ayDmzJkyJXQQXZLLrnW97IlcslLRTnPmP9i1uuaj
269+6Wa3zIKiNeYC/Y6tqvwtszA3zww0Q6LObtMKOpoe5yd6m9onU/SZcRalPrR3VdpPXw0rNb7R
2B1RGpEI9qy35ydbUbBOdxMOzZc4a4fHLN307dyZnkglw60xopHJ1oGrFvYpd5fK9U0rMX95fWxb
KPlYKzg5M00MXM5W7cMsuGH9IhPqV7xkzD4kqEq8Mzul/1g2ytzgCaBh/6Rt+kiNx0690XfWXLkb
OrqpPsKUSsyzta1/F0PRsWiuwjFNJ2XFDawdyC1nr+UIZxmtsbKx0jbAA7ihPJts3+cEN3vScZew
U2zF8I4az2aE7TAbn+fZKydCSTUdOeqJ8AJbX3Qbe7Ap/VUbjflOt0T2TPcTIQqldLPnkoD6k5t0
JZGt59Tzaexc+g5qrrU/+k3gvjQ5pWBCyhA3ATecQBB9MuaHJi2s7wXABtpzlC+ZT+Vt5jnJk/VX
2xfWH7qYbQdBeF2jjzbaqzgJh1wlwOqVuinGPSk3U+NO2x1IoaEK4jFRn2dbgWZvAzoI9Cql5LKI
NF78ynUXwDt51v7SGyv+B7Wi7m/cwuvSH0jsPg7U7I1A98iG4SRo/fvB/uDMybsua+PPou2UX+R8
QxF08zTUAYKxzr8C7sPfeT7pWtR7pbmG+mxU1WNpm+Poiyzvf0Cwsmr89VI3DfUpLTK/d+f8qQYk
nAeOubrf2q6b/80oEn1kdWIYD2ydJVCRbf238dLJCSDJK7UvMP38hmT+9HldhdpGDTrP/KnjzePJ
qDSjCSYEqGN/a4v8MxXQrAxUWnSaXyMM8H3wKNecV+w1rdO0xuyLorTiv/jHMqBpk7D9IhF5GmRW
55zBLtqkFpbifBqVFdU7Ky9c39CG8bk0WgTGMAR12IxDKjXnM49vMNRO2voGiNpHT+hxdx+joj6H
HCTvg52YLuZmy0p739SaPvEHW6cvmiHe5/hU98RnQrqt9/mEIicO1IxHt7HXT0aVq4HIDYjFQl3N
h27zNDatlrriYdBFCzOXLG4M0IRNKp8JCjzuHHt4VCw7+xjb41Kfirq08IGZVfOPOI2rj3baDTaf
sNGwILNH7c6ib/HceDbkJYdeD2Ei0jvdeTCxSFC8sQbDN2XvNvRbP3f/h70zaY4bOdf1X3H0+kIH
8xBx7AWAquJMlkRJlDYIkqKATEyJefj19wG72yYpu3W0u3HjLOyQmiqiAOTw5fu9g20a6971lNOc
VaTkNVEnRhyCly5Yg0iMeXaxpc4wNmxgnn2tSm/cr3NfV4dxkKoCj6v86iRX7QjzRZTQVue6uyto
RHRRRmP04CepzTqrKmzoy25yLvyhRVJemI1xpUPUcqOplMOl0XR4kpXkNR5I4GTxrAgCFGdEOac9
+SjZZBwcd2SpbBC73La5LB4zU5vSgyP8Od33o6zEocB8i/Mc9bl1EM4UUGurjBVJpkJ95QIzyGtG
UYJ8NjA+ENyR01RvNfb/lvqrgnyrLXmEjbz5eS2JOT202HfqJ+TSmlno8BZzXoxAJjQH5eyE1pD4
dYg8s78rfaFjtSB19D2VZ693JGsTzraWvXn0zbw4tQY4C6GYmnoOLQsHgZ30UtGdJKzBemymg6fh
CFd7H1KMy90wMJr2smXSeWeepzQda3O7KEJTVsVTIYYWozFcjr7QtG/Pa6xnE+hiRgsSqzzOE8uq
lpskWLWRFJuqZOluE2cOPSmRfkvNrnjNWGmfFnPihDWnmsPQeHq0pv0FyqnuZpw0R9+vVHAyNMkp
6/aOUiOPAMcK4srSLVqTvvZwY4s5lSGEtfRL52jlEDntCIefrpo80wdHfatBCTmIOoMjQ2nr1NVU
v5qKC1lR+ybL0hhhqtxaxMviaRdDiT0puJCTfbHs3r1cl2YSB1ZKa46VZrKNZYbkQY126UZ92xj5
adLI+cYZZPelrJOijqzaEwuLqZOj95oMlcQrVJM8rKfJGWMmTBHs0nLs71c6KAfcsBf/bMpEftK0
7B2x9ChN73Mnd9edyKfUOM0qLfvq6aOtYitzTBn3Rkpq2lwah34W9b4TCvmYbeWNEVWLKi94lpLz
pKi7OhKrlqrIxGvvai1QzD7YywxGPOS9e6tax3rKAheRrtsVk74reh8r+4qbHUJpsEuHut+yPPS1
213nbds89Q073QEzREhnVpcsHFJZdrundBp8tiUdaLlK9OWzYc3l07gaJkVB0y72bT5q02PffsuK
vSHL9Rv50f6XuVgr6jgFgD0nPQQTEyaEH2qj5zYx782hg0ue5bEZ/P6xH4rxc40ddxE2yI4/idkb
v3EqoahTrqGmcDE7ijobl8Piw1aVHLNh0bLDWGRYWAaEdo0hogQkJa3TD1OEicecReu8IhPSAzHe
tq3pfVa+09/lvuiGKywKqkfEy7kb+Z3htWGZaO2VN3fiu9NX5p1p2YoToZ0k31nY2Js70wY+Ivy1
TEN+T/V+sCvjY66X3oexWXS4PKWGkTzkhaKJZ5Y5LWY2FsEpxZM77/LamE/dleEEEXgbPTlKB9xS
MkSvftp7R0K/8iKcM5UhAMXk66jXhZXGk9ZXX1SSO085kkJKZzkGHzXHzCxcCJzyqUsC7bpql+pS
Tsa8E6ORL7vKaMstc0EM92VZN49L06MqK5NErbcTojqGhJizD/UUUKp7aW545CyidQzHBENE7iFf
0DRXdf6RB5aPZyPOLp+yWhMFmoxaU1dr0xpaPOpgrLHHeq9CoDc2JJkLxzsowwB6xRcideIi7U3B
8aQr5bU+uUv9sRMsGlHXWvYa57MOW5OVoD/igd6qqAq8pQ9LhupV1bb6cSk0l0AMfWJ5o/SqllAB
5pahkRHtGvqDDJYwDzAuDOkjOumJGZBGR0rd3IqQnrQadnnvp5/IuQ2+1bTJIP55c7aGPfS9D3nj
Et7Tu7r2tSQ4ZaWALrL3k8kuGgoBoja3drKGZgbRJ5zrtK5DLeF1Mh2rtDpzemPOiLcYrasSg1/z
0LmD+D731cB52syTOJBz6aFSm7cTh7SMPiLcQg1RiyeodjYRmyUwlfCzW+kVo836t2jzJ4KHl/Ek
8Nd+2ZWc/Uhx1N2GnjrRqGwzgak5gLDuoPZusorqpEGScGG2fb/EuSVBvNciyPeJMOsOIzzL+b6F
Q1OLTpXvnNZDPX+DK+qps9K20jbsNC8BYjLTMspRStxZVs1MynuPjaRuh7m7NokaLk/SdiiCqJ0c
kcfGvM6fKqsf7hNYlGmUD2PWRebUq3sRiDaNIFl6j5VcSWsdqmp1Q7/g/UWC9G0ntLW+/dzr9Pdg
e5X+fVEP2AUihwU3K0snvcAxvtF2eu8acmd1KiOPjp3ZCmeY7WlcuFJPY21NRx7PKjZ/wTRfy8No
loguTG+UgjgVrEgOrldgpzG5A8BxKmtrusL3oppuxs5zP2oe1jeRuZRrGyt7Mu8hzUzWrac4s6cO
xloRbqIkK6GqD7IQQDK1I11YxQdfm9h5gcRcGkCJD1aHUy72fAhiFgiyoH+Rk46NftJ0hWV+KUhE
Ga60rlN+hClTdZktaVOfBvmSXZVUFW445JVdhZxV+y+YDPU3rUHOejivtSOjQKN0jVgH0Oetjjkk
UeX2WLkUJp3z0G8WSZEvi/wD/lKFFQ5jFZD82Q3dFLrYSlc0XYJuOvQMDv8gAuI8Ij/NxuzcrKxg
OaeOIi7CU4Z/WjRKh35X4SAbFdJrPxRGPnyvctbPeMqX5v1ES+xYDjlHBJlyhjyXSVew0iCjIIdM
1X12oSmtnUN/adVICGaZ4wEuZubnnE11G+I1ZN+jfe+yOHcddTPPBKmcaBQNhzynZbqrRz35uuS8
l7ilEMwjv2/0oxoaSkxr0mu5G4dRa7dH4w1HUPc6iPt86LvQX4PGCmVl8eB6y0wV1adeD1Q8M8MO
HIi+P2w/xzjPBcvUWTa2fU29kqrPnqb34jRHqfTF17FViNc1bde4DCpSx4tpwdWReqs/9AOYLzbJ
CQmi/eLNTyXmDGfd6HDCHVeCwULEcFgN6aopExY3vxxDtPzpZYdI9cbPlHs0NZ8F3mjSUt8tfpOY
4ehSawMey9wDTBFZwLWGXEVB5gcqNNdJf/THFjM5U839t0bSaDtBEpfs63kNktituupx6KxWj/+P
lY21IiNt2ufbqbnOTUrNRpv1X03HgEy4wUDgizrMRpgVr/EgQ4xLbS3VvG9H+xK3TJfdtwMX/mV0
y/NgzOFm7CK7BzZ8fRm5DNqoDH3a64hGofiibar05Wce+j92NkghJi0RkRwNUYbM66uwxnZZitU7
MU+DvCxlVt60ZVCcGYlj7Zvat37iwvBvutobpR/G6+aQgIXaG7RwFY21Ok467Seb+D6HmVi2I7uZ
NX/ScDgJ/aqxowab5tBZKdZLeZQuVXP7q9GGDuogaxPoWVuPCg7f6xtv+5EdPDV77IXkdDIpwpgq
rAx++SVyFTxxICNzx8Zb94TcRDmTWlO/R4mJcLr1OsoBomH+Ggj9AezFD5PWFGR7faMpvGWnAn8V
ok5HnMSTabyUBfkwYK7OVj4X0V9f6gfMlbhqKKN0gJ59Ud5eqp97la5jUe6b3uuiNqvETTeL6Sft
gg0Ifw25IpmBDYXPHbgrLgivXw5f3i473gsvp6B7M1LaufJxTkZgNe0LkjII3D9jjf/wEHHu0v1N
DocsCJj0zXwrBkIce93hVVUyj4xSarEH4S3Chf+XtXeICRgXlB5MAQqYN3PAXDtnTZx+2dvE0ISC
o8lhxYD7J6Pih1f1fBW0HCgw6Fi/DV4qZFlNg92Ayytt3VEvr+Fq1L/s2rVdhf9tien0kd4SldLS
mzyjrxbaC7MbOqBWe9ET3Lh22h/Ozv/1SvDW/eO/+ftjrZaWyN3+zV//cT0+tf3QPv3t8l51f9sP
1bf7XtTVf2+/5J8fev0r/nEpHoneq7/3b//Vqw9xpT++SXzf37/6y47w3X45Dk/t8v4J2U//fIH0
qd7+5f/0h397ev4tt4t6+vtvjwgc++23pXz53/740em3v/+2iT//6+Wv/+NnV/clH4vrUlTi8f7t
J57uu/7vv2mu8Q7m+EaDQw3ImrPxBqanP3+EjRSWeJs/1+bQxXpX1Rxk//6b4byjz8gw5O1t1hUb
P7arhz9+tDE8EIvTRttcJ4Pf/vxuN7/P19/fD4/ij7//rRrKm1pUfff33547yi+nNUouPKKhxtIm
Qkn41nOUzUxmvTCa2OxB4FfpI8cubFMLEw3VcFQOFm1mT2F+Gtr4FwYhZjpd7BiJGzd56alw6nX/
Ka/kmT0uWgNwrG6MajYPQ+e6RNKB3gLTasQL4Lkzq1Afepvqpe1l3BhTeiFcbWmiDNrNRetPw4X0
x+WzIpTd3GX2WH5yB8P8WDXlcCAibT0LGjGfJ7Oqm7BVLY3shrhhJEjrlTL6Ztg/v8lfGt3/caS+
Gt3/wznw/+Do3pxZ//PoPrRP1f23V4N7+8C/BjeqUNIJ6elCHIX983Jwc/5k+9tCJmgwb3z/Pwe3
+Q7zBhsRH5Z0cFG3ff7PwW28g5tCDBe0NpqIiOJ+ZXC/3T4oaSCrUUdt1Q002+3nL0ioC3kGlfIa
GVtSk1FnN+5OM8buxJl7L37xVP7NPPpBKbZdi69r/u4vwB2/vpZRYwM045EaN06gXRKBxAxKbDcO
uuWrmW8n0bzIdhurmvhFdVNwaiOOCTDLX+ZxazDJKO+bwzSsnIM4fG1EiA6ygTYcprLel2MtY7KF
AiAnoMTKz7uQbAJsvQtgKDdTJTOvXi+roreOf31rbzd+7oytimUIzuMWcfOG/ecRGhXkCZdfNaPY
9yxxkTF39c502ia0YKqGxRC44TqUzu/T79Xe8nJxertb/n5latJtiLHabT9/8f4wRIMjh/gSN70q
3SE/5SCk2z/LJn92Knm1BCLl1w1sNXH55k9vWWTgTYYYgkDEkyPHNm4dXe3yIRtiPYBXGnJsb2NT
+kmBs3maPMJlSr8sGEE1k1y8yMg19wMtzjNvyc0DnV3wOKeore/Z5IsjbeO+Cg1ak0MsxjoFih4G
eT77hvwq29mLYWtzDKX/aZ1b9AJPh8mZP//vKvZ2j4aW+mJUbzXAq0365F704uUO/fzv/1jFPOMd
lRhGCNtuymj75xrm2e84A7A3B5s0kq4QQ/+PNczU37Fvo8QxITtQdm9Kuj/XMP8dCjus5ja/Vmxv
oZj+wga9za6Xg3NzSbFJ0DEQ3/Mlfgh88luLUMEMXsE4TlMoaryRBaZWp/Ui7CRMzaC+nBMz7UOX
5tphRLmT/2Rte7uM/v4ViCuCBYzy6K2HsCmbvKZP4O1SsNd921hWZGekvAIm/irRePMCxPh5M9zf
6PxvinCHKOekBI/dlWC1sa5WJ86qovzJ/fz4SLkjvJgpjCEpoiZ/vaxkfqHX5mDbO23M9euWrATy
y+saUbPUQWD3Zln0JyiLtSsXp8nPNPdM8ZOVbTvJvn6rpFazA8I5wpoMROH1V6C5Tr9EmrDxtlAb
5XbuZbEkQcwOUh5ml1azpSfayYsh/+/2qGcLodeXhZxDBDLKTwSnfIU3lzXLpCn01tnplZJpWGci
0081u6D5umYmsfLBbLTpad8aZGRmQVN5YaI7+GAFKq+v016zP6pVnxYc9wrnolIuQJE+us19LvoA
RkedpgL/gcA6b4wVrFtJXJqAxio0A4G1znkosmR1oYdUrIR8U6M/tH5m3+r+FnkknNn0wtaTwv4m
s45q0odGP+2hSyUfM0vIO16WfO8Vlv3g500+QqM1gv6klAbsALcJ3PfpEoivqzc77rEHBSs/2gDI
Vhg4KLdP/EFzv6TOkthXVkFP/mNuL1jj1nIdCWfKDTMyXNoZ0DvL8TPZTKLaGbMdqCvkuOaH1PWq
LlpQ6X5c3XUwDuiT2fzcidxPUGmb5lllJsM9sLjxCOinY6tfTtZ5PYp5pm9O0ytCAgNO2+ijoeih
j94llIdu2eGHTjvdk1CnwkH2ThqSRF2oqGRQWPtKaqqOlcq1Jt7MT0tq9R4Bf0lmZBZDVklPq3b1
G0qG0qLx7jnlXvhea8T2sKxTWCSDc+VnYr5NaXsFUO5Ikw1phPkX3gT7LsKo338si9nJI2R0bYm2
hXAuuvTyoIs8McLFXZc5cpkoVCOFetJAPj6sOTzUcJwlzBITIdf3Bg+SDKrJPJNQXeXjTdWOD7UU
SxMWkkBtKBNOloa2PzePSZ+U0YoY76TVptHbJWRSHIveyy6Czg3u2nTMnqDzwEyxNH1jzPirRYd9
bA6qK/qDZ2v+eZkv3ngutcD+0iituDEbq1ahoCV2BgBMnLE3W+blPAc+dIrVCI4jirc2pskEMApT
HQA+r0UZk/LQ7ZJ+aWjLV7q9RqNvT1ezkQ1NZJdzZcRBPQgROqaWfVL5mB1VkRfaTtgqGE5w3HRF
VHRFuiN5YJafypGHVoUpKU7uGa1lqiSFkKY6m22ZrBd4FhPbqMwyeC+8oBmiDFRaRnWXr4dubtHZ
mYvvNPGQVJSI66Cta9xltVuf2FORPnDKcqGfB4UEi6VNQ0t47O2wCWr5qLwajwYObDoums4IJG+W
rmZdS9CuJFowEe93OaXbFQzefo4EqvP3y7DUX/x+NR/RHwsg/kZLjti9+tdZLj34mY5KPzaDxxin
ldc9eVBrbwIo8HrEQVAeF2H06U4mekGRJErZ7X1Hcz7ZuPF8bc25+h5UPf3VgNTRr93qJw8GtF8O
fFBAjNDBjAUfeJs0vBNFbZZcj0W76PRk6WpEKG2GIZJFPRsha3lBNJU+T2nY1jnzxPBkcOMCdfex
Seb456QkWi0yqgGuVVo6Nc08UZlXei+tPHT93hjifFh6/twAi8SZOWzlK6djlHB6rezYnDi0RKMI
1i+N5moIvYu+unfSGs6xmfW13FflAJ4SWBqCm3qkDmeyYqQfC9/KMGIf2sUI16oLtLDV1iK9thR+
QJGVl6Mfu77CwH0YLawTtUmHjaBwM6WtIcSUIWIaoX8sRpPh6GmmyLCWpLXn0B39+X4eWs2L89pT
+k7n6FtGvWdpa0jhkKa7RrbWFJOPpGdndiJyJ1Jwbbb+iF/d+6ld3qyMXog7CLis0Grr9dpdtMqI
kCwlj1C/5aahGocvRarpt43mFAkzAskihhoeZhCtbsLm6aQy0hiko/Ujs0KYHhOomQfx1FXOLW6w
vXdS1ZZs48r1x/psGnpG5py37scBL0QZKr3yoXWRvv0zYQb4yautFDdBMFykAKQPcdx8qyT2a1Yg
uF/OTmsG51h0xxqc/EyuhXpvezyrv95D/93VNv4v5xEqMsrC1zvoWsNgdDvp7ATcvhuasms8EV69
H63Cvsxk//TXl/vBNuNZQIldEcoh2LyYz76+XttWa8sSYu/GNR2OmS+qLMycwYNZ1gbrEDr0l9po
yqScdhJXreojvAstifuRgb/rA/p9cWO7aoHL19mX+lB1sF9SK00iluTqqR1hgx6sgOYZwcBat0T2
kor+qWL7+1n01bOm9WX5QfEB03oD3YFaSTKhZn55nkPDQdbxZkxUDISkRnbnBcaDnY0du9GaB+45
BdNsnjay1NHcGnrXwurZOsuAPu7wexX4v9jOC+SSiJ8X4+2HU9HZfXn/Brl8/sSf5yL3HQohExkv
Hrk2QnB+2R/Qpee/29AeVAPkcQEavjgZGT7oDsJV1G4eQDqqwX+djLx3z12XDeHZVM/+L0GXCJbe
TH1wAYQ/nLU4aFHovXUzMXtUGIEy5H41dIyv8BMQ9+RRUsFNLBWUn3WlIIVSrLyvCcGG/NGRZh8T
DDQuYaHDP4lQKmEuXZadokuqGSy5A41ZYJTMu6DzYJU0XTcOxmzBqh7cQjvxRIFLzzSMC5G0wZqE
CYo+E/LgmH9WPc7tO6KKzrIkK98vhbRURFcGKzM39QuY46RW2WjXberVAiolOwtOoulu9WDChiJ1
rE8lRtdWXEEXvygSs75rCgiS9CRcvqBpJdd+UVf0xHPE//jsD4E8NE5n3HSTXgYnmVXOn1xfgxMG
z3htoBfrQxmVzWRDxOuol2A6+Fc1DKM5Hk1jfkqNAFQWLvv80QD8PZmNvCgjfYVlxl/LYc9qb3zG
hd58gLuHpBeoT9wPpttOYWPmKRYRqWOKXT+Ys9wZ66B/oktqf847UYoTOMnBgyea5tyeJsfb4Xej
qYjk58bG44YW/N6r3eRB6wMPLknt5nccxe3ptIJZTdE2ZLyczvLlnfI6drxlIzKGtNE7wsuNJFlC
r6d9EqG41L7CsRmNMBGJY+/ph/k7cBvvvtZMH7cATfR3cDGyxw2U88PaVcm1icuJCLHHbK2YdIf+
K5Q7y0JfZCL/VMBR6wV6VHmnIeqIOrbiMRZGLqnY6t6ZgXM08bW1NZWHWul0NqTbwHoamwHYHCX+
XMNzb+W+6xxxN5qJVezcVDMjzYZ7GHJkn3BpgxQPD1MLpiQak2yLGxlG++h2UNnIJsqmM3uxceXn
AojNfrKV/XCsf7ZdoK3GTAVufat8kXUHxQiyyp42VLUTvEQqXHwBevbrn1zqxxM30nJ6eTQr2Mm8
t+f6YhBF2lKw7aHc3mjeKuPCm/BPd1ptB/t425zEeKH4440h9en3/vYvrfTX6qn60LdPTz1Nqrc9
p/9PkHy8mP9qtb+8b4lxEs1ADfJ732trbj1/6E84X38HMADYhOcHAcYoz/654G9tLKpuXiLNJxTn
G/XhTzjffsdSvmV06njlWZsl259ImP2OGpQfAaxthpjsRr+AhD3b7L8sHzbTQUgBm3sFYB21xOvy
oegG6DZ1VoEJNTDk8J1KTiSkjyF0l2W9LcfMhnKce/t5stY4S4fps7t29lPpZsm90rwTsnVJTTKV
DPBUmM0Gyqh2qEgQQhA1ax/sHteAFfjiVkh8pb1JFofBnEBlclV9bYZOv61xBnnqlHNMU69xw8XS
xxhnsuZcjmZ23ZVOcgajJ4vcuvWs0Fw6+8rfVDFeCQUdrphvfHPLwbljkrQ3y2hR7q9z9yFVZgfL
si8dssCE1X+QWkUItqOK74siRiVsFqN3QlHZ+ieDY+63VcJJDydm6rGd4S6kluphSs+2zZkPAhW0
UwcqR9GPTr23xg4qVW0su8RK1zvXTVCwso1c1gARX5Oy8cKgneB2Y4NO2vvipbAX4aCc1kFufivq
MT00ebCHanSjksn4CMNHfbPE2n8qCqgPMAQNbN0gqZ6tFotYVCgoalTlzanbulYResFS3iFtQlay
zMMUZsgnHl+M5H8DbTHGXh0CaIZSijBqaWVuOZrbz190CmCEGTaQUhU7bhfEsD31U33R/hDw/e9C
8qbhberUbP+5J3hD072v//ZePNYvV5LnT/25kjgsFxvASnXmbDjri5XEewfeuZnWspQ8u17+ayWh
dMS3F39K+DIO+/CLrrf3jnkPHxamF8sM8+NXlpKtDH41Xji82ZS0mwQeKhD145vxIsYU+6GuREXn
ajt0sFNsd6UnoGriJIkJOKcmuvZni+l98PUBbnde7ZQls7OiWHUMEl1BIQiAkPW+H45S8y/cIntY
IKeeZVlDuVA158aABlpoY3CdMk3OmmLpdy+e+78Z9m9hZDytcKdm6AOY45779uw7KbLDEkOUeK6Q
6astQxeXibhxOD9FGHtCP5bGFP71Nd+WDdQLLORo7onsoV/2VtyPnAjuN/jtLlF6HltB8Z2Q1K+B
Xv6qv9/bC70Bq4dgXgVNt3RHsfy1lXCB/TK4/eubeTsOtmtwN5yst9HFoeD1OOgHiwN1TwEOS9QP
26mbYojA6iev6fkg8nLn4jLUfiT4gb6DMT7L/l8sT7Rn0a+rEodUfwjitCjO6zL4nAiH1ND2bmyH
jy3Zsl6OZYJcjWPpzzd/fZ/b1vjDF6Cr/nvE/A8eP249GoGSkP+DvL4oEDBcrr3ZhPmIJJG20s8E
7D+c9J9vGA4j+RNw0wiifv1cYYVbmHRtKtuhWaK6EQ8ZoWnYFfhrmBTedRUQXdM69hERy3caCB/+
+nYh1vx4wyT2bk0eC337dtJ8tSFY1azZK3DYTgTqjKrzqtBWc2e78ns6qPUI1/eI0qU6lKOy6DgU
D6hzvxNSdKHMXoZZqbo4XzAqrfU12yPQsm8G279qBGxjr7zwNfdqlfl3nf29Ej483oUmwzJp0NMH
WPFGTiFQwkC9yQ1DhbQPv42FJqJW5/+A9I+rlVthtYoPjtF8zRP3tvPtY906R1/nyraXfgSzpaXh
yAePo0/YrG0Xb1cDyEV/y9fwA5f8l8q7nTAGRJljHO0hfUiAXsJg0L/4iwzCcfuRk5vOBz2Z+x0x
421YZH574nazCeeGSxVdRScCrVAMeLQe7bb2YzIgulCN5YWQ5lF2HJ+e78yU9uUyNsu53WxrntAI
EtAmnHC9Jr8UeXeHOJ+7QngBDWEto2me/FjDvWIXOO5VY00A/o77RfO66nPPiSdGoBdENbY4HG+Q
lzj5aHFHXXAwYRuEcH4e3MK7omi6cmRfn+Qd/IYiH4L94vi37nYgZg1fL31lj5GXZfimWanAngXh
KjvPleFUWwkWUHdpWGetnnVUefmQL9YnU5hmHHjdXVJmxa6koYS+tlo+bu818aoL4Ew/JF86ux6C
ZAfz3IgG5XcRqLIej8rWdnbWWqHdoRect4f8/BhnG7hU+vgGZH26fPQwHkSCzkNYIIXvK6MKDkum
B5EvvCsCZ4KD0y7LAWtPH9cS8WBXSEmtvFd7HcPTMEWAues07AKmzlpP6to51oXrnNc+QwGtg3M+
8RgyaCL7FhH0Tq7BcpmkCZJqzcpjhxN7BCZO56lii2ua4rs/qTsz806fv3uREn+rV95pVa5jBHX7
fhrN726i3eJApvYQsmo0ndzk2GTf3SVd9yhLTWygF3TEhjc+DWLs6XgszUk+FsfSpS/t17O5Exbf
Ow/Eug+S7g6mvh470s05OgdzWODMFRuwz8MgE+nektVyoJpk1FT93eowADRHfNdSm3Tqpb3rZy/f
zT5U+0mjHUYVXeG8M7O9BkJBeDGOgYEyUYx8M002fDqpLrZJo4/84gnHngh0BvE70x3RLnAiJXc4
kkAQ2lnCrx4CP1zK/LszMsmKtXxAIn6VTcalmUzXjR7clrA1Qnom+WVjMeCJqAsOIjG7cJjs45qQ
dt90s49/n3tVVbg6VIXwwr4KrozFOmJI0oWmmz5YAQ9mqQ2ukbR3hMpfABvcaRpPavHEZ7ANyCYT
L8wAtka6nGm3kmS3y8zLltDOSaBwxm2KeusjeC3Auu/f6uuK6VCp3eomo3v7L1YK37IrHqqUKYuV
zW2XGdpuW3z73svjpmvvZGkeW6GYtGgtEG0y8PUE3S9u4zv6NIiszMlBIYZQ2bJZMlavnc+U6Oez
uSQxb+smoXzUe7ovdnaF2GZNIgxeJCJiXo3T8SV1vPQvdVqwmMD7TFFVPDg9HTKnRFQWCsLLtIau
VzvW5WO5Zqe57RMRr5jxnWzvWi/DJ224a8v2Dg3O5kVN9pPntizKHuPEz/jetZ99LwRuIs/zVFPe
bVno64FmjKD9OKAIqtv6RGFCvJOo2mJI+2bkj9rtvOQMLi04C/JC7X1yDd5jn1Z8Gr0EYYKeyOVQ
BMmTDmwVm7Ol7TSbTyW6eSzy0qIz0yT3gP+czLayLwm2pbGZjQvLQ4WG1M4xDhYOCVCjvOna6HmX
oPbzjW+xCNI9y3e0xq3T7aQSTi1Dmzzfbgl5KdpJKhBiFq12v8xpdmP5pYnzb12fDCYLfu7Udy6n
P6YN4ZsXNk5EeyNdzffGKpJtQC/t+egtrLRWrhFXm2k6FjWZwyeNQTspbb4ysv/lkKJW2LXLyEpf
Wsc245C5zsMY9Tk+/mBnsvvcFll2nWtVsXNa5x6afh7bRtnFU9D5MQI//Y5TpnOOSYwiHlxXXwzN
nw9+lSyXWkH7GLuA7KFLtfy90LV7o0E6E6Gg5/1JHS9DxH7azpwMczdOjf2NrjZOGoY1RnnKZBkL
jo4YIBe7GWllTOPf33vNqN9xFn+YZ7bnbXHCcXA+s9iwfXxj2Knau+dtkbr1uEytSaa9VFGnb/ti
nrTn6NUQnfkO8eWMw8pjGigWDAuMMDZLpz23jV6Lum66pmcqvtYVK/jzGpEL90rvVPVBq+RDWqjk
TKV0LfuND8ISv+0pxS25hrRGXQ9RJOvxvIIF01X+PijzRlnDZVt7j3ZWfKm8/DxHG0onmiqhmxEl
11XJqXrUTXSzTDiTJW4/CA7ftV5A20Z1HdI7XM7nRs8vltnjoJL4bVzrQMVMulMzHz/Ibiz3ZqEP
cT878w1pHfTqpm4+q/BxjKgo7/xqu00gUy7KfCzyZv06iABOdPYgMHAK81Z83wQEkdFsk3YrMJ7L
BeSad4ubPxB+qNizOgtF5PizvJS35ELq4mfQiLYQp0I462/qtJKjXjWv2f8l77yW6zbWtH0r+wbg
QmqEUwBrLWaREkmFExSVkGMjX/08oL1nc4Ecrl9z9FdNlS3bZYkNNDp84Q27HDPFnWUr9yMjcWim
v8ek1f0lQQIbDFbivx8hWmuGdxQRW+CtTYCpq3MfaeAmQKT0Lns0WyAU2MOHOLGDrosvDHO4CzPU
DGoNNYkIpTdPbfOAeOTa6pRHzW6+pDh62FlJSdnkPl9Mg5ANFTW1bWCdNfu0XT5FFI29iMTNj6U8
Dzv1h3A6BTKd8pnC2SdRt8BjnHrfTIJqUfSgyf5nqudnWmSDjmBZD3n4u27Tzo+L5AINGMK0fJhu
hNJlF8XMXi5DDm7aL+fjGruPVNW9dc2JFGBLyamTGqscTs4JKbvsw+wA1PFaWG8+qFuixtxlS45y
8UdnLryiziZ/debc9Yp+Qkj/VYJqrXAjionk2AI53Q3UqqptsE2JowSWThACR4UgTbPOFzv6ndac
nlysv9//sM864psPC2Ae6WIKECyprZ+B3htl14S5EpTrTPFxTIwECG2N2I12Ui5fe8emxcitUuTm
YQidmzWcxMfd8Qp30H1oiQTwC3fuGjOpIyHQ+pVbgoHZyL7jdpEFBWcIGhDnczIEEl7ieaXnv5u6
/WLURDr9Ql6TGne4r7rQ0KDOJQl22Ou1r8dJvhs68043CR3XcFNZiBwKgnCpsjsRSMl2QElmL6aB
S9RG0vIc0w1t7fqL7tw7ki2icD9lWaucaSNfmxb8Tb3wO0mkvkypJu8rV4dzLkdokm7EnbyEXON/
34zkXNHIxTDOqrKbphj2mitbEDxjzcGKpAM0Tm4FF2nTNbCTAanK994as2ANt4yk+YJKQLcjeA4v
IvTCvz1/vj8qsd1XBX+9W6T/fwPlH35VK0dDbn/U+jT/TUz5/4NjAvXuxTp/1an99AR9419X/Y/k
6ajktv6pf5fcKN7bK2jy2VZ1ray9LN7D71gdpgFKEB+u5a7/FO/Jj8EWqKsPBX0yKiD/rt4bf+Ed
TzGVs5mWFw37Pym5GdseEEuOn7ESAuAF0DPeHAXtLLqwhp0bJLOxt+Y0cXcSC7y9WsWwOibxAzWa
5hNguu4q16B0U1yXOKrO1SXl3BIBEGHCju3s+a5cGgdeemEuT7Do46tuHMurxVJT4FJV08C3DuP+
gz61V0bhmreZortPJRbot9EM4ElJEs2PQKI113JGQKpxiE7hO0vlLmxk/E0rZnVf0CEud51ohkfU
ySkVqD3xYR4WZ1P3D1vrj5b8/4X2FPjq00v8MSl/0Jz611P5819d/Otff/NPkvKXPFr364/697rX
/kIqk4o+XBKDKtsL/DZNK2ALlJ/QoTNUQg0W97/XvfEXHSk6SXQkEf172bSCnUJReO1nsSMILbQ/
WfavKs0UZglw4H7RASMu3l5H6GC0jrJI9AmGkgB3LEpWm+UO6KTUrmwIHWWmg1I1jMeUWkWM9ox0
boculw9q13gqECOCgkoP9yZ8i5TaiEhJ44BnldNUXdUJhp7oUunRvWMhegPgtP80d6sfd49W71kq
9RPODfoKOXp5wfJG0FwAvoObgIW2NWtLXAVdnrTMAiI1GUT419yaNSzdNDViVJ+k9JAcJPl0kV1T
5yq/Nlpp3vVOnR3IbhF3MLoBgTrtNs3N8QJkKN6+MZolViR2IWjYs65sT5lNb+MQnpmeA7aqFF9B
TqgbGBWKMqpA5iijFFMU+25cpl00Fo/jUg7AINHz7EI5nggxtTcmiqAHHjBxiEGhfNOv5CO5RoWH
ZOAOqf6QpfNjPXbQqnudspdtomHRWvsUUWWfum2yr/FfPCGU+FyM33wrk4apjlIB7F3IO8fhtd3U
I5gPHqHGF31nGXHizaZWfpk0o/dzEdvXqiSliCdrOWhKquwyHKpQweyIxa05voxJzTyjzn7U+Nl7
KVjcE5P0Bm+KPg97E0drB/D/tlK8AAgp+tJmkozHZLjuyTBaEiQK096ADETToiuRfiCI9Bd1ugDP
epUbP2kPIemEOEgoglk/KFFxyPnPpXcCwy5pSnydndQDhVJPNmqFyj5xkTU85WS7LaqzqGi/QPHQ
V4rbqyJ3E6dliYdzGkilAvg5tUCJ0U/z3QzQ9YCi8/mL8/CNbs+zkcjx17ToppkE00LXhL7NWRwx
mG4PKjuAnznvRye/VDHrOVQIQu5yTGqvCX6/912KGhs1/p2TLbUHzoLKClUAz4GQeejC4U8NC0jg
IE3jyCc0jA755/Eao4TWkn/yVG47rQj3WPerumvPOGOrYFboSf15iPh/4b5cz4v/uQm7+9E//aza
l7fi+gf+uRRt8ddqE2TB2cG1k/Yr0dY/0D1X/0vl2IahCKMP5tv6v/59Kf6FJzG0Y7jKHJf00f87
FlTEXyrtXEBC/1Ck/gDHscaoLy8QsLNATNbb2GAJrzHr8YJRpoparE4ZaMmqfW9n90Y3ImzzuxTm
WT7BbCoPff5Ulo+5feXYw05DxbCbqnOMEQ9Tox9ivQUHPZ/YXZvdzFOBq6NbBG2LwgAp6/FTgTIP
4U4p7q5Xndofpqz0R9kRpMZGv0ssQN0vPtcbu3kLZ9EAL2K3gRb72pfjU2x60OFiUvshWt8lSy4V
D0EZUdx01oIoxRBn1Dojw2xbbyzpmPiW2qfg2rNS+SRRK1YDLZQD+TNinTf9MidQCCOoOtCrBdXY
USWaBUzefW6yKWx3ZZY6iKcBpa69ZjL1LzUSZJEHyWL5DGhZfFNAFEeH0J0hpA6OM6af6MMs2q7Q
xaqfVSVNuF/fxCI5pWyCXr0p4gOMszb3ardNcApv1q+JxB3ygmLRu48h+mUavqf5sqc7NYhDsjgR
iMUZqdJc6XNzj8Bgv6cvqFqoyxrWRVPl5XhIGtFAQ+jL9HMkCvB4uhlrVlAinrfKToz9V/DMCgwZ
RN73dZgO8Jg0nUQ1rm0OnCQzEeIqxeSmhFlh1/luFJETxLBe1LWkWqImEYNP8M1wXn444TOUKESM
9QIVLEGuXiABw1UnqwyC7jh/AH/Y1ztLn5leqjPg9xfwlZY3OHbR7aKWVhbCjSvqp8dfwfJUNRcP
/YIEHb0hx3qcFEwq/TEfte4M7a/0hmgNvcL3V9Mmu1oXEzbixK0Us0jXtoUWpU+TfCpmY2cmhjy3
1Ny9sXKqs14FqFXxQ0TlzztlBT7lea8DwRxQVzjxDK/2NX6C6w1AIG4LZDs2QZZE4sjJAQ7sAD/R
9c0TmhF+2MtFvcByQP1dK2MhIEKpKGtNtGzl/v05eKUyDiB5NenkLlLh1D0j216igIgdlbZfMnU3
JqNx32eNvIVGNgZzX7RX/dCX524eldDJEmopYeJc0b4c8ZYqSh+hwiiIBxyE3n+mNcB6eWVDS+Aw
4YkIFuAprDiYl49kKxYROgK6QYzy8rVrtv0HuqHtw/9iFJL3FQJFrrGFMURwmVCvTbRAN6byck4o
3uc4Sp6CMWwDWmJna6W0YgQDygrRiuOXaaBHhshOa0FdZc6tOzjiY9925i/NjCh6OeYN8ulfOJmR
W6Y+vQr2nTKz3ywxsX2CTTzraPTjU1Q/AxbUb9ss66CSZBNpsgDpbWx/jMAEp81cniCmbrbXq3E3
V1Y4Q5ZIkgKwRNyPF0ttKRdpY35rMLuNvK6mFQKfcv45k9zFfqFW8+37H3hzOT2PTxEVkLtlaCto
6XjmlVJJ6whOVcCijvahiZpXHIv+FtBdDvHcsL6/P94rxMo60SA3kCChfgv5eAvgqJQi1KmpBLrb
ZjsFAnIg1Vp/iHNL9Wk4puciz2DU1cpws2hi+jVbSE6KPJq6E6fK6x2E97iKecAKz+H1NzuoUjmb
Z5BhAd05fJ4p+340mzm7e/+Ftwki78sORZLCZnpRs1gXwAuEzuhUKLfVgxakppred+6MSVo22ffI
tCG5ULHCvSjOwxPKW6/fzSSeWtOHZ+mhZ5n7F6P2ijvTiGQ5CwJmL417OsxDcsppb12cx2cQfY4V
OwfOhF+3KDGYzWLmc6rgSmS8n4qpIWXgRCy0NP/6/jS+XqcmjRwdBjdwTJ0L/ngaFycmxKJCGSzx
MF6X7lg9KhNpXIaj2Q6ianqiGPHWqwEjXD30uABBKB+Pp0yTKOlvqQG0+OYgBiUnqBzToJ+K+MRQ
21yaY5lDDww0pJc1rjY311tMExrEW2TtYFINyy7SSsQWRS2q78YcNmAoLB2EgeY0wxCMqTme0XOr
ygBlxXq+QimHen4XNdPtGHU4ImU1VPPrKaFr60WjwpX8/pfYzAxPS2CNcbnpgLPEJ10/npk+6kx8
A1LwGPBMAqObqyDr0mmP6UZ0YoduK0J/j4VMl6rSR+OQ2oTOkD6WvqRysOutXv1GcQVu6hgK+dDC
w219OZeO7i0ZUsAHqNAG2pyRY17ABxgRLaY5Q02oQ2gWZu7iPhUplwtOHyGEm2IyzHspc7XEa0Xq
cJJtQXsy1OZcO//j+VoJTUgsCKaLVOB4vrIM6rvA5mcHcMO5AkPtXCx6O1/aQ9Z/fH+ozVmzThen
GaE9OfzqzbE5W0tInhAjuZ7NLtYOIJeXO7THJHFl2sqdVqrhvWjS/sQJt61EPg9L+WC9uFdhiueO
6IvDpuoxz2zqwtgVZSI/pk0Tln6CSv4jdHC0iXsrzVbm/xD71Pem8y6btNHvCoSo/TSMu8nLDFla
Z90Ck4Nm5mJdJDCjqkMPNxooE5YW/gAup7zQRj0Xly03RxFIUVQ/ctTpWoQzsXMAkJA6f4gUfX6z
5+KeyklK23Oz1kunA7gJZWmnt1F3DaUVyUp6ysH7n209S14co3+PgkUMOlmri/lzue/F/IWUwIoa
4RYkq8v8Cl1262dlpVa0SzqH1jE4elQucf8te9O9B/aYnbgs3hgflusqs0QZGZ7rJgYpuH4lDr2c
o1F51bbGJYp8F7Hd3DRW8qvozd4rHfvRNOof77/35kxf3xsoJQp8VOmoJT6LSrx4b3Qw9KQcVbEr
MOLYZSARzyFwjb41NNC+KAb/8TyvAGNEh2hlOTgbbu6QApkmF/lLQGQQn6/cCnlbs4jL84x8Gt5G
Ehs7V9GVg+miQmsnpnXK62sb/PDG1ADYJVjarZ3rrVc9rSIz0e2GN47H8JNtF07rzyO+FeS6HWoY
Ffg3yhEW3Vevyiw0F9QKBSHPMobyoUkscaqUvIkT1gcij2DJUQ5gcp57ay8+QRsTrClIU+/WFgj+
NeVvY3FOyUg+v9Z/Fjjh3toJhNkNkVKlmrc11bHBF4AGdSGZZwgVIHlviR9wsrQpcFBcN/cFx/xt
Umq4zKDU4OiBBLulHyCzgxCc6vwrNFGwMHY/UXeEEocoFFgVeRm7SyLB+kHHp5aDAQzyMUv+WWYo
JJ9FmYOKRJu6gHEX2c2/3l+8m5rp80shX8VXpEjJqbdF+rtRiJlLgpDvKpApI52INrVGivCF9QMh
9klFgDFXviXga1pU4Jse95d0QiRjSaadXACOmUkp7kxHyR7ef7TjG5onQ9ISrRsY3jwcClubeMJV
+NZz1tqBA0ESYQ/HmFDXnZM7J9LE4x+ORfcW48BVbnBVntzWmvp+bKRNowz5TIjUrRMVQQ891J9s
dToRDbx6rTVroOsm1rOYzbM5jN3Y7OZlphJPXcm4yqYRbzE43gdE9O0TWdEm4WcK17GoZCI+B9MY
F+DjSxslekddasZCz+Zm4ak4j0Cz9YVm/3ANCl+OQS2pGpZ+r/aufhFzxyFFkWGKhJHHvski80Si
+PrtUQfgdueKXdOn56Lfi52qd21paNLm7eF54gUOa6uxRuvcAXT3xxN9PNQm9rXNFhBnzlBJXLW7
mfKGb8ucc7JbohPB5HHEss4zhUqNY4GcHxPMrS2h7qQFLp6OFSylOtwOajs/VnakfFym2bkbZKQF
WV6elCU+PvX+GZULl5WLISK3z/HXxT0Avu+Q2oTQo/0pw4LWc9FQOXcXqZ9hFu/4CJ4gEBPP1c5C
wfuKI726ja2k/TloLZJDgyuGj0ve6H/+kclvLMtcy8Um5pPHD0bTMM1K1OiD0Zncfd10SzC1/bhv
k1Dd/enGxTDPYOINiParLPTxUCPy/uZYWHaALaJ6ZkQIRaFklt2olZ0/vD/UG9PNUGvdf71mqCId
D7VodVOxsxlKWrYvcjX2VMR8Tqza4wrO80d1+Ok0jUjXGGcziqWItjaN0KbnaOfpXk818dWQUXk5
FaCJvEF3+w9WVS7YXoWn3E83F/vfg0O1YjJpzGK+vhlcosmPcVdvB4tl9BdU1HskgBrzg1WE2LMU
sXuIMNZ9pL6R7wu7yc9JAZKnyB6bUwZ9x8HcP08CuMAgPaP2sO2BqGUU1u5U2tSr5/xaogX/Q1rN
dFNMjjwzEBWHGK/XD/ao9ve17MsTjeE3NjR83BXfQPFhvfGPvzWC82raIVwYuEKZLgtFNR4nsw/h
eHb3RP/9XiCA+OX99fXmK8MZQ/+DC+jVTWyVyM7gpmYHU4Wwd+bqFO/Igs/r2FG+c73OlwtA48dR
ztMhLazp/v3h3ziZHWpIkJHJu9bld/zKfQZ1H6s+OwgdrdnHjtHfTmvPtMO5/Of7Q20E1f/5ui/G
2hzNal2NrZMv9moviDtL1ImLKpXGATXP5nK24vbMxoWaqvwy3Al7DG/UaMq+4slmXfd4MJw4Q9ZV
fRTXAT2hQMLefoZzGZtAY0bRpU9G1hpM5QoGBwB5AqHpxChvz+9/RtksKTx/yhLYuB2UuTv7IdU2
DF8SjZaN2gQn5nf9We+90SbGyLHJHfJc2oFWW+OHxSoi8OKF/iFeRT/QX9tBukZaqbHR7JSJMVy3
47jPc+tUSvjmO6/JwuqiqqNpsllTVCtNrgI7MIa5DRYRLqvhiLGfEFQ78c5vDbVqvBPErXVge7Ok
4lBiIC45uox4Mg9524m93kxGkFPjOXt/eo8Tvr9XL2sFeUAgM4AbNkO5eQ0wdSIwHUtajGZsrfTO
tr80XbPYA8juToCE31qf3DschiauB/b2OgWXSm6ADVigNVj+9HSm/AoM6okY5q3jB7VHDoDV65Zg
+Phb2QVGwo3GKEjByYtmXJQbY6UEKSoI37bMIt/tEuMaA5ryxhjHU9YRb524L4ffLNnJkLbdDuuB
j4MlcnGxs88zC5WPUah+RqzsUy1KD+9/yTdnVlCKpWBA4XVb1RZDpFYK24AvaaK5YZb5+UzkcmKU
N5cm+DZCXoJ+yr7HM4v/UlFj62IHaa46MEEmcVAjHFxsjNbef583D1b2FLUBSuZUODdDZS2xSUaO
E2RuzgpRGkogFvSkM3iBARjPeTfpQ7VfzDM8WOovjbCXJxrq6ryrKeqeWFFv7hMbxAsvvcLcN7u/
Nlu7ayWzmw7klyDFm2tYNe61RD0i6MeuP3//7d/8mi/G22Q7aozWBQ1/Xj52V1mhyPSQtHFPzPFb
o1AftKgco9fFZX/8NcNiUCpD5WyVQKo+ahCvA2VEJvTP3+XlKJu568qx0JKlZs9bS3zoo8rey3pJ
du+P8taeJ0g31oY0toCv4r2J6iXmQWy6vGkvELZIFLzh0vHrgAZogat50lC4I1/27Bar20OuD/2J
R1hfZHNV0XGB2YJ+Nf+yTQhzNzVChKudAOXC/hJV6QXWFO5RJZ30x/ff9o0jxiW+onImTIrw2/67
pYatOikQeCc9Kr9ScoWgRLlIyqpGp0hX96gEqPv3x3xjtTDmir4VpGjk+8erRU6zouQzY0bw8QJk
6LQLVWDY/r8YRWc50iYTaMev3/lFVm0P1rLMbe4EOLaWgaNXv40GYZH3B3lz+lYtXq6itYG1OVty
afSzpfGlEqOAYaWoDmbSnHhfF7vXP1Bazu7GFDjk+6O+OYFU3bCJobJHknf8akThhhXDJQka6hLX
lFrNyyw+2c7V31iFAq7TWpdBL21rpCL1JekLRePoGKfskPV2+/nZx9GJi+WqVrruPl2M5YBpGDIS
YI4PWa3P51LPM+FB1zxVjnpzqrFZAYEG84DC5vFLDxoKzFjPkmrGJVZcY4JzE7Th5pDXc8fRXYzX
s2kA8nl/rt84DoAn/mfYdZZeLCPUjm2FoMkOxDzKnV4P4a8F9ihmfG4TFFGToidmILE/OrimdZiN
nhj/rfyT22IFgqxdUnbq8QMkcoo6RJKdQBgjoWqFKx9elAZNdW+RaOx6Uadq95Vemk9KTgvV64ql
qNAnEZFKVcumCfP+jKw6fa+OJ2wYqESipOfSRz1+os7qYmOCTRUQtgIaebb+1rsc6Wtcv2+SXNG+
TL15SGWX+6ke4pMt+tlre2u+X0bT/CXb8Ktt5yH068Q8b9wo3atYrX9IrGRMvNgJhxNdkLf2C+25
1SoKsR/gCccPPItcceCzAvSdSsO3Ijs+V8PQOnHgvLVAgUujM8WCcTBNOx6lQWGKbmfqBG0OJ71O
VmUHF6/qvWZE08EtZz3yo0pZTvmYvb4t0LVS15owlVpCts3lW5ZRmtouyYOj1ZEfA+zZwYjOITrX
/9BO/kdzhdeFGIZC+A0sPzo4lCyPX3FMa6V3wbpBPC+LWzn2WobC7zAhjQv+BH9HQ02v+k61i29Y
Bk+nwGLQKLYrjyUHJwhJEiDyr870se7nonCiMMj6sDf9LGmyX5nSEzoBNDRv0lx3I8ygVesKjdNp
2Vnd+AlRYdqk0pB14pllvFg7F3lDJzDbJR0h0BYQWKWFjZGPlVMaHVCFNJ8SpPMgHCxh2O25GPUb
Z44gaOro94y7yFbbj0Tk+h2npv4kI3DbKwu/wnKjlFgOV0UzfSi7FMOL97fe64VsotdIdQ9EgUCt
Y5OVu3SY9TIly8pEMu5kZacfWwqbf1yqZJQVk8Fe4a7ahh91LxIRuRnltranj1Mu7l4sw69ML6YT
+Ii31pPO23Cqcb+8qtbiqQ6fBfU1VApkfW6nhv6g9njRG3VLXU+Z+ua3jgASLsvGqTbAm1OJSC5K
hsDjCUSOlzI6oCYenRSKyeW0yhunWu64TpODoc72l3CMmoNt1TWcXFydUWPPDi0t6ksONW2XFgDG
lCy8E2ib3b3/id9IV9asdhX9AbXFv2xqTp0UXG35QM1plgIeqSb1TxZI0HtaP+bNhLR2AS5Cy3/M
kYFvddthnukvDpvQnyYlavwC0v4fl/54JhT8yICpCtFNPp6sJLSwX3ZnO2BVVjd52uGB1w/LT82s
qmBqlmX1OoZV9/5UvHWwWav0EXBINA626OpWj9mEGP4EyVKMfqQLxC9b+6c2ac6Jo3uD06F8IYgo
kFlapWdxdDE3L9iGmnRdiptBg8jdhQNU2auNKfrIcdNfJU6CG60Sj/q3vJPFvk9Ff6hKx6T826Qf
9aWofziNGf+sJ129tZQJblAuzSR4fzpeXbvrM7IwgEKxV7RtSS6MIiWuAc8FDYKwtz06mD/CNkRc
YiXXerLEl+FQW/H0u+fRvsz6Ig/vP8CrLbN5gE0E1uK7GwuzVIK+h0oexe7DMsSnCo+vjoR1EPIu
4mkNt8yttxjqHAj3cM8EqaNc0b27yHKj9CfFuGrFcNmZ4qOQ7Yn4YP26R/nWOuazEjikPlqCm7Ng
bEyMrRWUrqDDxdCcoyLi2LNaktjmkJSR8uX9idywvP5Zbo6zBterINpW21QooBdt/IoDW+3DIOpx
l06lO+VY4Jrt72komu9l5QqAfZivzg0YQqs4lbO/2l3rSxMwrAgNuLXb1GVincWRqBSU6Dn/Yg48
mp6quOnrvv70/vu+uXBeDLWJv2hromxgsXDKcjIvUjv+uBRafvb+IG99RIe2Ln8/g/s2g8y2OUwR
dLRA1/MYZZqlXhyMhfGuDwupfp4Auf9+f8RXAR9JLLOEfPAKlYTJcHwqInw+g8BqXIpIobzUnHy+
tqWd3+VThPPD0qf5vlzEKSeaU6Nujqos7JAhnFs3GFy32gsgRb/1Jor2jXSHABHt+kqZZXjiunz9
BbldAASu3CDEu7fIwCZbFgzG9TAw08S+NNXSusLX6hQr7PXeZxTQKIQ4LsGlvXk1LIuEs+hDuMoG
zKg94avgxyZN2mTEehuAbREdMPCYR69K81O+oa+BAahIoLkE7J6SuUqIefw5M4WQMa8EGmOunt7I
3JG2P6ALcW8Z8kpvCs0v8ZY+n2Vsf0K+zH0iM1P3Fu37i1Zz40shm1OJ/lsTQqgHvwomwAqUPH6k
OhFJW7ZNGCAw64Dyq7KzCSPjx7DVMOcw9UpcN6U1FkGpL+mJNO9vmvH2WIQgAk8P12LMJjc7aoTV
DjtjiHax0TmX0Ypj86OpWvpdateqStJP9IPDhPiQRri7oc3XITitJmOusvEgORI8KW2LElFjiUPZ
1wnW1oaaf+a2jz/Tc72tQsPtvZqej7mLZdwKL86MsvTdsGroJFfKnOzCpDK/xD3m5YfJqGywGJVs
bxs1NLA0UbTxzhSD+qE3WqRvUrVoez+jalGhUKHkq4CVM1genTKw0n1hAEOqMcxSMWgbjJ8wLabf
Jcj7K3fJpLvL7Db9PHWixNCdxi7ldZy9Pxn1XD1iu6byPvXcPIrMVq/DwZ4Q1ctd3C0bQ/BrGSKm
hmGKjWRtCdj9x9JNeuwJRGA6DwqQlcBxqczpwlaHoYM83M6QsKuxnqiBJ92Zi/aK8O3FKciBrbqP
rhShz0DYkYn5jhFnFAVWs6jnoFP6zxMAaawaaiMxAqt2qvgOXTCJSXqaOfeZMbfZsGvGpi19SkjO
MPjCUc7UJnKBXZR9qy1BvRStrT9otIhIjGzer2gCB4RAMyK7VYcPSWTQ2UgctbrX4ghjhkNvd/hq
dc3YVl5pxE0MHaoY850WZy7OKyHeNYGweq1FLWaVulMa1X7qpjj71g70vPxUxdEF80FzwmYndARR
d5+NnVeIibx/0dAD9DU7mX4NwsAunR70r3jM7M7DE0lF+16JIhk4sBeWR+kUWE9bZRNmZ9IyEfJf
FrWrvWmiHxTUmoJoU9s7hG0NIvuf0PCngqPl1LCCWgqyVj1rbN3LjbZbdjb0tOWC2NnBM8g289ir
nXkV+4uNCMeeSAMA1C2T8ntuWAOTGDTKK2bU3lJpaamVZnYISZ/QQdmnedix1I3BunEEXos+dsQo
EsWVQEynpnWDHJ+E/hYr80+6AFCYsUWJPjaI2qG2FYf27QCAET8XDGQaMgADqJUiiuwL4qmEB0Or
5x8IL507nIfqT+AQauzamwqZtV4vtdu5xtnFk8hYILRviHG4akIk2/ejrWj8fPADg4fGlcw8vpwV
I7I4qV9RKmoeqPQM407oVHTQH7Pa86RV1cFLRWW2mIHUExqI8fBkuJIfRBMQeqFSZAu6avWwfBJh
pH6i36l/E5QDYy8dsmr25n5p78tcigmNMWcwAQOHlhXofaJGXl/PC1sc+bVfnRHOFymagZkn8yS+
xRd66i4MrSguMqWW5UFy66O/L+KpDdRYGUEKjsgaREoEALyhORhdOdKcPip43nxbhkzcCml38ZmV
xnAX8zATSNw6eubFZCnXppIuaFqVtv1j7N3IYP2NA5ZmiqUvHnBAnJacGaKSX9DGxGvZiBER6VVD
9sGMxcKvpsuW/HZQEI70ozhVxjNLnTW0H8npECXUpyo5j9us/NrodflVCyPjEUnGOfLUph0yVO+E
+81JI9QPZsyYKF3UUT5hJzGG1O5wgcJXTcFzy6vw9MKx1ogPePOM99aU6WdSxKh+Tfii4Q910Wd5
8n2awY+hHpqnX2KhJqgAYfnJASxE+70Yovo+Aiav+Z1jdV+Ql7O0M0vYeFByMPSWn/VZ/KBGlvWg
p+iZ7E0nnWQwj0kxfaVqZuD4MJki281JrN9NSThMBzZFyFMnhor0TNvkiCLNYKi9Ik2kfYkWmdKd
h4gBG/u8pTKFgcZEj9uVYVchrRnail8rYJJ2c5RnyR5yVJX7ajepFxZRau5ZVM0Vys2Z+q02s6U/
m82qgNifK11CiYssB+W0QZ0DW+LEFqDtBpHeSnQYFKUqUKRzcNT4NkwyesQhFazXIuMw9Ouhh142
T6qCSmtq5ep5FWOF5NfYLogzXInHg4M5ueNDBcn6My23jEddGfrwUFdWW5xLe+hxIgbhhAkdRnv8
OiLovu/VsEgudWtSDnEs1d96u5IJzQnrkKtcFGPrOSkRtd9LE0O6rFNkeWsvVZad5ei5u17SmRp4
NFD9CE/1QIXhwS14fzhlaXzOzJrG70gqpJ6lGnJdDwb81+Jnl6XjGNTOlKApZska2Wh3PERWYj2o
jbt8MYlAjR0nqLl4iREmny2jhcybjtAibrIO2tIuM0sE6kKFW8fTdJjUABFc+qFqn1OrNTQctZAC
APZh27HyNCjSLajDUJoI8ixtp2BBluobEL/pZinSMfvI0h4rBPRrjSdNlB+tafY90vph9aTSIsl8
SMZL6XVWGHF2uJ27GBdJn3MJVKWCcAO5ymiiT6BkOA32LiCCrG27bCdma/6cFJ32qBhhWPtRknFO
KMQh2La40ZWZZK2OtUnB1a6anXkfoUf6pZHmQMpuTOQDihyQCuyoknZ+2mbxZ6O0tcivMlk+FCCH
dLQrB+032tfdr9FY5q9QpUc2XmOml3bY2oQM5WxjS72YNrtLUetLNE6ncl+G1RwdcsxdzoWQfLOp
LM1bCin5N92O9ZtWIMgfzHNVdQ9GmybXXblgC4vlbnMj+V2hR0+2tnaqHmffY0OLY0QPy0JgdTgQ
zllOOvzStZHLOlJD6yqt1fpbj1q44k2qlnW7Ye7gHiOgKi5RD5XdeZIsTXcwMf1zfC0vdeAlPRBl
3xxizk93WUS7h3Rj3mHFOX0KS2duD3adOPXNsJgjfmMjZVDCuN616SqwrpFCi6qGmxQgu0cWVMbB
DF0s9C20jp6yrixrQptCkf7AvFwrdgUK2q6gi8MyxwTAb9LpItTbkYZF8csYYmxO6sbE69iIUyTG
6NaI0YLYnLCEuG2oIQ14mFTZZe7UjbNX3TH9WrEfO3/olTwJMF7oFz/vTOWLIzU2oehi+YQk7iR8
rFUUsbOU2rnAVgzXmVZRYVZqIOaeysk5qEbeQV/neb2i0PVDWrWq/F5MdqTukiLXE4wMi5C+xeSu
bFQSBIEJjsT4oFvs5cJIx0oN0kUZL1ulj2+Ai6Fno3a2+TFPMo8y41Ihvmzy1kWWEh6bjc5VMup1
DhtwqLi+q3CpOmCvyjhDaa7LZmdU0XSJBaAaHlIFvMDOHiOt9zj5J9R/sEPaNUWF5ZAVJ81PfAX7
347aEBHhr1xcuzBshBe1A8D7fE4tFUqUg6QJaVNr+K2+tCEBEdzr1VW6QrC1EVHvJ5WCuhyRL8eZ
S88earsQ5X+xd17LkWNpfn+VDl1JEUIHvLnQhWAyk0kmvSveIMrCe4832ufQi+kHVtU2CbKZ6t2r
DU1MxHTNsIsHODjmM3/TeFPM1CxJlnysav3cFnidSEB9oQHDfy9FxDUgNasBcKZTKLiwUEKYQeQx
pe3XRXk6UUWyfX1S9izmeSfg+LczjXa41PCmxNk08m8ivRBOhMaYd1YXGNfZbGHwCmr2FKdIzdb6
XtkWHfaOcazKixcjGnZpB159Hkw7Tpq5sMvq7uPE/20lDmopfGYINWimUTh8nZb5XViNvjD5rm4Z
2UGVZskpS1U76FYXO6nkx+eE1qHqoJCjnCMCox0Z/23pBsY8qTyZ2TKt6xKxMVpD3Y+phaZL2jqD
GHfXnDIE4vlUnXz8qu9koK+GWmWg6PZXVRFT42hyIdyFidTcCEEqUdjI6m06wYqYy+pWJTB++Hjg
dyoOkHngTSGshXnMWgNLz9R6oNFtkVGgzpomSeUJ6Gt4H4/y7kyCXSa3Bupormuqs5gnWGzFlgsb
LHvIFMNsbBPK2pZ621FGzvuDkUiDycatYt0gtKIELn9E5UaNx8KtC9qjxJzX1kTG9PFrvVMjwu/m
r5GWn79oWhdZHQI156vRCht3oeEXOyzjZ9CGBjDdoIS5Fybh7ceDvi3AUQ5b4AIwR9nma7E+rRv8
sMTW3Z1mbGQnGc3LSDwPyzNMt47Rrd7ZgVw3tFkp2OtQh1cvWOdB0TZIe7t+JavfkRnWBlfRWvWG
9rjopn2U3yL6nD7K3Sxtx0KT7z9+13dWJ0VTbWkVYFBFl+b1BA+6T8AtUzFW5MG4r1J4jIYS9T8b
cf9I5e//TbXyov9et139/Q+cqpo/uMS/fW4xaPmvIGKpMXd/L1mExGwLDeOP+6gOovyPkwYRn2/N
SwUjWLH/LmGkq3+iqgVkGem+pYi3iPf9kjDiR7BCgPkthPafEn3/LmFk/kmDCUTDAngEWmLS2Pit
Z4lnIfUgTiJ2LMwrEKD/QMXo9Q5ZViuFNJpLVKmhPGvPUI8X25J9UZdjo3OYqjUOCsPYOHmDKAwy
5On048U0Xf68Xf/Iu+yyQOWz+V//7fVh83MsBHRNcOt0N3mJ1ytUpEqS9k2Mq2eudeivB7Gno+3i
WWFzZC88s7P+ut5/DUU3gxL4Ik2wptJi1W1ZPmpH7jyETq5Yp715n2fj4EqTmmyyGlPvse9P9MQX
XH8oHyeD9MEXL1HzL54y5UcfXCM4E3uagFMCWhyNP1m2oiSy06uACsLY/XhqXp+OP58XciqBKrA3
PFxWhV7sd8n4B4nTcULxdm4q0VEGXKCNYV5UnP3JFVDFO3LTqEtQ8GqWsDVihQEUg5Sj09p9/UFS
xEhT4AuWW8YElmZVXAVV/wPEQnoFcPrA4blYDg7FIYzQ1B8VyVMn3Tr0FB8wmEZgv4zdKDKv4Mol
DmvZUZq+sIPqUPbIBSXDJpKkiQBURwV1xpVIy/ALRk34aUJfKE3K4mao9auxb0aP8BnnEQxKIHCb
oacZ0TbRRNyIFwybVPqTU9cWtkBBCcaghHVZC44y9tGR/u6q1c2HADAKo2RZokvzdU3Fq4cxGCKA
VG5oAjQg09IcZUq+5SmZR0QoCXQveMxa3M+lxj8j596DYac6Vwb69uMlsSr+/3oU9omCgidgtzXq
eSoSQ8XXxXJFK8KEcUC8fioBsMQZFsRzFbdoIImWF8kAaSWMpBtEoiYVF12tehh6vT7ScH9zUiwz
89fjrGGZlgq0PekLy7UWq8hAqQK3B2XmKN19PczHrBZf32Y/X37B0i/BJHa5b9Q5xwAEe2+BJ0QE
27aGtveCUu+P7IBntPxqB9AqI9qCEEg9UVyOrBfHX6aWSDBEveUKqR/b/dg+KcjzQ8fuDpkw9nYQ
z+40msq+DBUBwQYN9C0mxLOtG6FGmTcVKaQazVYfs+tSkXNsvvtdnhvflLzDBsA6dMTeh3kQA0dQ
uo2fy71XFtFWUAXdDif00qwePX+0Uip617UmXXR+o54idF65qK1SKqScZ+MSQnl3iG3UaVosOZaa
U3dSBVnm4npRu5lgbGmEZ9R4mtoBxvZZEONvST58CgKxOjPxKxCsYKZQLda2ZnGkJNFdHxUzKWJF
papAQ51xQi/JcYeh0HEs3Xp3LQOtp4eGthaazqujPxyp4esJ6QGtiMmbRqeIA5y/c63YtZpwG/Zh
cSqJob5BrVOwMSGYepQ+oj7Zg+L78vHGep0//FxaCwmRCu2iLPKM6HrxzQ2rxNXb903XqM3QVppB
t5E6QiL/qzXYJa4D1MLbYwKh7w4KZcuSiehlQsTXC02cEV0oAwbNg8u+ba1NoNNxUcHaz1Ft2CZ+
rCy2Tx+/6bunmQ5niv1DTgZZ8PWoyB3Qgq7IJRqtO2nQ1PaIuZNtn5D497i2C033ZBSzgMWS8TSJ
SXSa9doObfbwGJrlzd3P6QHRlEAIceO30GdaEHNBAwnXsHpQnSkTe8cXMbEJDfyUxArXo5mQ2qmC
sd77dUwNncKBJxvCeUlQsoezKxRdQe2gjncfT5L25u7l0ViWBrECyq3Uwl5PUoKpa6DBgXat7JMC
W/Iinc6nhOLSoG/otUvsHbHcFqpyoigOLIzpoHYA73otouuYaVRPgkXQidbEJNNaLErrU0NbbyHH
ZFgYXEdy3ThhE1vbES1CWwAg7hi57lDstv0+PlTmYHq4qn0ao8kNrLq09eSzLvaWLUysDtxCqP/u
kOfzbbDEudMVEUURoUKcRg8/00EW7XCGpF1I85kRXFRGDqOEchIVmeZUEKvOHTKBIgATHQRj7OoT
3AsMbBKcMlI0wY9xx9+7KGiVowxjABeDpPR6PlEkL/PON0zUg2j/K52ATHnryW10F8lIXj5/vX/l
Iy+8beWFvPL3+cjN5y+fX2Ufy7/+W1Vc+ROaKspJfIdfKuD/nn3woyXrsH555C4lst8CqsafOpoh
pC063N6fgeHv7IMfSVyZy2lCzIhC8T/JPtYaqgvSESKriKfuAup8Q4SS6EEbM30wd24tYTslxk6p
aFyb3fBDnmesH271kh4Jzaav0PNPLCmiKzaX2IMAly3m+izNe/lAkLtJBUU9aO3PE/QfLa//H0R6
KRx8uMQW2wava1pS+O51qrv8xd+LTcYSVUOXCV4ysEDoun+lugpqvZS0EJFEkGVJg18uNhinywH7
vLBQwPgr1TUQvl/WGpxBCsuctf9ksT3TEl4He0tuxYEInMZkaa/SnSxCOj3OJZrxlW84kwFcZfwM
Nr3d5RZyG41GNrOflDp64Kzk/Bb0G1kLXFklB4zjMXOwn3/Eyine+LOBkRJy3XXaXEqDaLcdqDXT
KG4wSBe31OWvimF22jiefl6k/1qQK+9ebQEofnTmLSvSxgo8/D//ln7PppcH4PPf/WtNLjqq+H9g
MAuge0GO/y6/yDiNcEPBwHherctK/usA5FgEbo5U9KKwoBIz/HUAshKhbQI+glhBzeSfrMnn4GK1
Jp8517A0wHGQjr++LEHO1aOZDLIrzxrFhZim1tgKkdvHd5yEEFDlbdUa363Yv9XpCNlZGwlejQ2O
0bWW08rRrX9m1qa1UdEsHWKkcXJLOcmnWLIRQbhvRfgXUHUutBaAmiTv6T5bLuA8w64lod8ao1HZ
eTyirawVnyax0rY1fsE6hP9/Ldy2nq6/B6uFy0XLnfjR0l1W7uEzS/d7/nLV/vqLv9ctBybIRnQ8
kbpb3Duo3fxet8qf0lIOAIyMEtVrD3vzT1FXAPHCllhoeEua8Xvd8iO48OBQQe2hlv6Plq3E1lhV
jmj0ADM1cIQgp1v3DdqiCJExVRVCywAYEUgd29LAocFnKcr7Fts82y/y2y6fwATEAbyYNCKtFsee
mhB1NwUwydSFx4Coz3nk6+0EzYk2qGIQ1/CnVcIzpNUo5lqvuGUyDHaLtvhOq8VTaplfCEsFD++b
J2iCkh2m82VZ1peoHnS2mhb30yxOJ0a6NVINf+PSvJMkICtDOdC7Cw5kzynBNShC4AMaUDzzckbr
0DUGA4PBpKchXSvxxg0SNXUsc6Zyh+Ojgz/eVsYaUTcTUvBynjxqHqfljC/38xL617Ww3l0SXaoP
d9ezw9SB3UVp/r9v6s/48PyPV9vs52/4vc0IWWh+4Tu+4KafI4yX24y9R/UNZXuq9wvX4/f1YP4J
RH6R1wR7RYCyCNm92GbELBCkLRTKwLP/I7ep97YZticLIp8iKZzP17dDMiYNKCRRoX8lybuiylQn
VGbRU/LoGIVyrX66hOLcj3QAiIyo0q81CRRttqQxthRg//OwMxovq7H7kROaxkoxOsEA0iTvg9ip
dSt3S6ToJ+SFTPz4bAo+6rb9AYZOg/U6W66pYhAD0sFV6/zMSERt8+KbvtNJUJdQ7c0+pz7L1YxY
prTGuctmawChURQXwtk9ckgJ5XwzPTPN8FBQxYGkI9oVm1hfdrNR7URxykFR0PTLGlO0NQH4TYmW
DpBE8wucvVujjgynxD8TvSQRQGWnuMiFVQu4wk3wg96M+ARvlUwGcRtdpl2WeRrkEzc+l1EbdHLq
0oFZV86AsAhg1SLaSHK8N8X4tMZZRYmib2gzIfFvDcBjKn+v+YXm/esMeO+GXXYDzS+Ey9BBXLD5
C1v/70PF86L+UaTJrz7dy6Pg3V/082DgDvlzUQtdePSQ4zkDfl+/zz9ZUgguZ3p3z0nOr2NBkE3+
EhkOux9aGpwBEvFf5wLmbNzaYG0gZ6BIA6z/n4SNy77/a/nDtoIWxm/iCIItyA7g6V6WrVMT4eEB
/YWHbg86KrUxqD4iZrPiA70dgiPu5RAA8hDRnRnCNe+Cz/1jetEbjDS4+THPh9eH3JuR1syj1DAK
tFAYqfDq3eUxOdD3X2TR8lYo9NNgW2V9Qb7Ay8IhfMCcBYO88/nB34i35Xl05Ex6Ful+81FeDMTH
fzljqjQCq5TH8AGbDCX0MhDlm1qyrS/h5qS3lb22b/flqX/ZubHdnUxufa54U2jrrrlJTnQXpq61
kYyfh8Lf0qNXkdqv2X3xVMvsv6h2p/EY6DNIp4fa3M2tk+w2xXfMYTZQWN3683jfP4GMO6opsyrs
vB12dXOFtS+rlcGw4l5y69vxZD6LsbJ6aO76U2nv281lg98BkdR+b9y+2N7vXA7vvjK8+iVApsIP
TeT1KwuVEIPtb8MH6Wve2yYl2afC6T5R7Fdva1zoLpJNJHN828mRzsLyi9cr4OXAq21pybVci9Ky
1CYPD1wwNPP912J35PVed21/Tu3LUVY7swGzSFjehw/4CdFULT+JwGUzWjrLgAsuPLQjwYHv//G4
z9yat2+3ZMsymrdvwDT0i2Izh1X0oGZenTftJgim2RtMq7RLyju2Oih0rQ39Cg5zCqz5RBF7DKtr
vT01JCF1uohcM+i72hHDsTikknoOvxUH2NG4iYX6ScjN+wS6iJf5mU+zddzmsvCjmIxwZxR42Uig
KTejQrszbx7maUZjfD4qJ7AS2v09u3+95eq4yKXQAJEtQwbaChftZXAYryNHOg/s/n76In2CXXCk
r7rqjb0dcXVu5Dhu9L08AwK+UQHJFrZgq17mBbZ5QR/GfER0/siXXH7jR19ydSb4U1r3CAWFD5WX
fa52vjeZTueNm/SMzkTj0FTuL8FvupkHQ2OCHuM2gWeZTp/sohAuqj3swm160uzSLf87uYDgeOof
ObiWvfLmGTFpWTp00O/WZHjY42KYtzxjfTafWueZG/+06P3bk/E5F1yPsGBRiPw1IGLP6IgXJyPu
khXOVFH0kNmAFLZ1bx+S6+K6/taW9mxXjuB9peVa3Zmf5lNAxhftgxTYkG+e2tOpO7TmRj+ZLuUb
aoN26UwPget7Y2z7gW2cCBvpZrwk7DRs/3vsWJ8GW/tWq24ieVeiW11235JL38bg6nSyS5tWTXD5
ebCP9dCV5Tt+9IartZyGlSS2oRA+aHbnhSewES4Ee95UDvLWs4u/0LUIA2Yf3pgnKqykzez4tuxm
G/WLbtdO+ARKl39WN6HX2UBTnI+X4Uq05efCf/kBVgt/mqY5VyU/fJi28dm0F0OnuU923bbftYUL
q85st+MeIaYzZOkvrbPyqErJe/vg5QOs9kHel4PYI5P+kNjlGSL0n3De3WHceDpcJs6tsYtdkNBu
4jzU+8bFa4lFUe0rp903h3BTn45X+ZfLz1/Hq9SLNujKOI9YB7jKJzNjtsLRjg/Fg3zdnFIfLg/D
aXdkG69ATr/mD3AEceiCp1qQZS+v9lBOgOXAeXho3dbNT2rZ1bfWV20Dn24Tb9CrtmwMv25mr7uI
vrVOexe4P458wmUFvVlhhLVoQhAp8yivH0EOA2Ey9Th6iO7le/m7cK1+Q8e+3ecIr8wu2mTIRQzZ
kRdf6Q/9evEXo66CixkBXI0OUPQQb8oLbSfYl81Zuw33w+mxLXR0qFUsUZdGacFIYYmc5/CJDpwI
/iY6yT3/nIPzGE5iZW7x9s1WEUSlWKB+ijx6ULf+fnQT1z/3ndYdz2iIO8L5+EXwpk/iCUggF0u9
k+YmcenlPhz5qksE8dFXXUUYxpQh+prx0mzK7bAtd/M2/RJehF+s82CvedB4Dn3M8kbwlbNz+/Ho
z22YN6NT+MQtltwOv+3XaypP81HKfOag82Y3deMLvLZPUzd0BQeqxo/hE6qErm+Xe/k0cOvWPZgO
5L2PH+KnwMKbp6C+QF1+qeguiM6Xm2uChlcWKnPwePIlsyP78ebw5X4TnVMud1lx0EtOC/vLyeGL
YZ82NtGJmzmebHv7bWmH9uWJ6mTOheyITrbP7Ed9+9TY8Sbb3nKGhJtrL3F2Z6G7SWxM/tyTS0/l
/Xr7y32wucnsC/+EW9jZnDq5U7tQsexDwBCN/XR1MDanxfbpKrEvZv6uZm8MW3PVrWhfjW56Nm4O
F9j2eI3ju05qO9vJvfy+ufx0/dWbLkzUgrx5E9mHC9HRbPxN7dPe1fcXB9V7ug0dxf6R8KaH+ye3
sm/vK/78tXYn5+Iw2+pJZu8K+za1Gd+WNor9uPFPBC97ngBpozuhy29t+K2z/f3iyeDhrgo3s2/O
J/vb4WnmFdxTwfWuL+zaPqMWbGsn7uZqfw/l1j7wPt9qO9rc7b4FG5OHS53S3t11ju98e/S9+yf/
BJ0x51Lj+kqdm4Q/F84Fc7msjvH0C98jsAEr8s6FI9gnmn11uHF793DS2rfb0X6atk+nzjcchPi/
nmBAMb0zpyZ3OXx+t9lePJGpEXNZziZztpAuN8mhta9xonamS53fgtuDy77b8Ptb21Pt1k6WP3z1
NM/bmrYz7hXHufH257qdbE8uN6P9aXfHoyrOtndOGvuS0jjr9uzh/OY0dc7ty7OZ5Xy224PCcSrX
25/tvesz095b7mNln+46+6b2TjTvjEEcIi3b8VlePz6bbuMQkc7Mz/aTaqusuMvAa/emzfF+6Ozz
3PZ2GrEEzEanc85vZHvnhfa3eaMxocr+a+huh42wV/a2vPlsn99NbnIb2E/4vW11Js675h+lvQ+W
bxfb95Cn3NzOHTCO9tl3w/H25dY/9faSszzZ98LZuCKLrXf0i/MzBuI5ndI5XESu98Nz99vvS6Dj
nX87dM6+8yz7jgONuvqll3vb77MT7yrv0O2vJufQu/2md6VN6+4Se3fAMdOR9/fs7olldbi47d0N
ZHavdu/uDxea/bgz2BG9C4tq6+1a17DvD6dXPHniEpF5pZPbk33aeRf3iWsX7g/Fvnn8xkpetpFh
/8hcb3d373iXe4T77PPtJ6Yvs3/c7x4Hm9mdqOx9PoMpaZ9/CpxP02b09l57BfTOnr3eE7YQC+34
1Le52/nPNrcJ4jY7JrvcY3Dq8luX39c5sEVclGNs78674+lab+87N1ePXwb7dHQbJsSw2XkbpApO
bu9RxyMSNZnCK8NN70Q73ZXn9T539secxFcV1F83zYvzbQVIkwVTj9SK8w0TJPtROH2c3S+HhlVz
z5diw56EzkF1ZKa+cL7cblsvO/lK2aA6eTDtsyV2hc2/UZyb/1hUCBSLFJfCLrTt1wdvGYOyFASa
8OI+PxE9GM3wXU+CxE5v4k1LAWq40HcmCGRPcXIW3McH/7OYz5tz/8XwqxvYCq1QV/NmiQnlq6fi
fDwxOAe3kaec+zv9Qt+U++SiOpLTv5fsIAYIb4B2mqau31kMk6g3lSEC1hyVXqj5l+h9kGxI1ecc
EoCNcgyK52hZH6vyvRe/WRQsQcgvLQZTfj3ZKNcVgwSF9mHw5hPxh/lD/TQ8yo9kJOXBuBRuf6la
/aM+1f8GR1J/TqPP+R82/JDP3R/Fjz9uFmhJ00Zfm/8CBJFFi+vvC85OGKXfX9aZl3/9d79J/xP9
XsJ1GrrEyr86usBh/iR6BoiPZKKChA9/4XdNWQID87wcKfUuX2lBzvyuKWv6n89oFhAE0BwWBsl/
vKiM2hJV62UlUPXGewzk9eu1oBipEqPJMJ9KodagN2IWenrVYgDg38l5Vkh3YRAXX17MzOXPffWS
ErKKr9FxpR9NNZzeE0k+BfdVKB+NWpD5QWruDfsisK8fzs5viAU+HuR1OPt2jNWLWVOvlrqWmPvE
fnziruP4+mf76O0Qq1Nj0susmi2GaLyrx8PtZexezs4n+OpHXmVVzX470Co0r1RYq9rEQKdLyHkb
urwMWjvHUvPXB9KbYdbRry+HkhgXfJbEp4FfbI0MW7Y5RFqIzraMLqWSuZa5s4wbqUgcEUkwAbqz
j1Ey/T9bUfcJ4mBd2bn/qS+57lGq0+9pnjcXF5azPa/JtP9zQ6xOxAp77N5PefNsiYluW/scIO2R
6V2y4r/uGGg+mJUo4H1QCwWdS8vo9U4DBz6PmWW028JQBw/VxhDPSEUB7C8c85Za1vZ6KExwFFpF
yJ3S1l0NJfgyrFwo+AIdx9tAg4iOr+VuQKdkP0CrsNukEo8s0mXPvhwTD3jIXYtoFnz0xV7o9ZjJ
pMZzomvZrmqkZoNygQ4nuoOmIMv5PkOwdPvxJ1vVuTivGBAN1uUwgRhOA+71gL4QV5TeZQbMKH7L
tap7al7rToEuktuVQ+XC1fW3bRxaXthWxilCJOWuAcqHf0tQYZ7TDp/LUoQB10oSSUdJZzeNopF+
UQRHVRj9+FrQM9NutMw6GH6go9wUFbsAoMi2HPvWi5reOMFvMTsVYnjBwCQVoM9VtdHkhgjWEENP
TxSJP2WpV/bZ0Y74es5B16vg0pZaJk5T1uqMK9qMhJ2cFZ3SUNxYaZpuimLoNx/P9LIwX31ZBNAg
JMHYAlILyXR9zCF66ifiXG0gosBs1/x+g/BAfWSU9faQLUlEaZ4eA2iYRVfy9eecayGRtSlTN/Ak
6vvSzIU9OlTDTacb0u7jF3pnKORDsQhYVPWRy1tNm5zALwsTX91MgZG7CSPfTVnbeeasHrNLfW+o
BUeyQAq5/te2hEU2mQUCNepmlgLNq2rQpuqch5tQDq0j58ubzwSTg/tbWoQjcQmSVxMYy8SLfgSb
ZmHse7NZDi5a2MdC5fXRAjQG4hR7j6UAHHKNwfCbjoBusLqd4Uvyj7yU5tCpUzX6kfoWx9rcGOWN
1fTWL6zT3xbuV3fT4lKDrQtUaxiyIt351dvRmxGrVu39bRDgKmbrOAQ8ployJBuUFiiGakb9KSLW
quwUodpj98P6cOOwAacOYZbWP/nJmsQKrwLFU7VJd1KCeBnCVIWk7UZgKJh41ol4LfcImh05UNcz
jVsAwTmiP2QHgBHW5o9mNtZZmwv6tq+KaMepGzyWSOw5TW0op7M5F2RJRXtka6wXEe4LoAtxy5M4
WNiSq0MVMekZFotZ7LIcoahQ1IpDVYTREZ3T9a54HgXrBdo8OjRUfXVX4BMUTGzAYlchY3tK3a+w
wey0m6QZhSO74s0scjMsIhXEyah1iwul+mVFL0YDxpjDvNy1I0xG1297gyp+l+HZMSB6V0FPVRg+
qIr8mPHg27fk5iWvo0oPtRSRjtdDd2bhI5WFv8sgqlSoNCU8RZs8cvJuSM8/PtHefjYD/BnJAhsE
oeL13p87oS1CTZ92yMnX55qf1lsRi7YjAe97o0BcBzsND0SEwPH6hQTqC4GRNdMOQUZh0w5RjVBK
/uUfvwoAOg513EVVUpJlK75o0MFnbTJLiIcdclqzh9bNlNtxFHY/Ph7mzY5mthCAoRFIEEEGtloX
hTmOlSqlw05gG14YXeWfyQgcHsrJnDH9HqevH4+3SkdYBeiV8nWgARo6EKL1ktfSMuimYtzpuRpc
6ehveZKCg1OcIXdYWUPitmUre2bsU3dUouLIp3tnLcK/APTI6U2Wt6a8JpxqKEH1A8JtQMn9MhIi
G2Mc5Ocqvb/7+FXfWSbGImKCTBoMJEiIr78gwXQGQUcadkEewTmcUkt2rEBEdPPjcd57p4W7B8EE
zpK2lgX1y0aJY8WaduOk5ohACUazMyniSNuCwYqTj0dbJ63IJeBAy4cDNbp4TK5Pkibq2shQUmHX
B4NibvC9qMxLUQiKe4SZhfN5zrPmE0Jk5u3gm+Z1XheK6VUh6mw2ukBWfOQMXUuF8zxgzaDQQFjA
Z1RZ98qDUY/VeBDFXcA89LYcjb21FbCySjfgCha1xHbSGpjihKYuh7BIdTvUe/QeYrk0tomPgccm
1QzcITJhjum1xK1wLwUR/W3sKY6JHbzZADwuYkXkBgB02AKrDTfqRozu6TztYiSavuU+Ti1OKCOo
FeJ2ejrImG9YmdkcOtDVnixOwxEzgTcXwTI+6qCsGL4ediGvV6XRdqWmZtW0m5SKhnduqY409Mjs
Z1n96PdqdJbz7kcWzZslyqDUV3BahdAEonj10nO3aK/mwrSLorh/Sqw+7ZwgaQrf7qUc/vXHS/Td
0bBkQAcGgRAgh69fsRySEYFTbdrlfdTjYmA0kR2g7unIoSweWX7vTaepEKxzhS+O7qs3Y9v7A2SU
aZe2AugjEiOO6SnqdlaBI0SB+qQ3GgYuXx+/4grmtYiWMKPcDtzlEHGgRLx+x1BSwtnAuWmHgllt
V4Dquy1iof6lEplwjGMx36VTvylLI3kQg6G8UEfdC3IlAZ1XK3aKesRBIrlA8igN2n/oPvj8dARr
qDcDLgGtuZoVITKEFBksEa1ITPHCvJlu0y4QBhv6QX2K5PCx/OK9zwD41MAOFqY91YXX0+EbMcK4
QybutFRPERzOrUOlNMVdqVaB19UgtItBF46Al94dlIMQJDzMbuKN14OKqdILWijPuyodcP/J0Yr3
tF6ubuSoDq9DRQzpkpSFYhz5+O+sb0oMMGOWSJxS6qo7O1aLYEYbibtosErYJSHSyl7q9+Y3nY/7
8PFKe+cl4dIs9Hn8+ogUVhe2MFp+mhjGhNaYKLCK2jS1tUjvzoewyT2eAx532TX/NJBb7jEiRmS2
NXzsrNXdqfdKgRawPu9EqpclHBu1qhxxiI3A+/j13lzSzwNxGi8TuXhyvv6GZhgqSkrdd5fFYgd0
X0EHdBSPoVXeGwVZLPzNyRiJgFfBnAjlcpTaQtq1c130ruaji+dCys+OokOWz/GySLEEALCiqKwB
kX5r0JvrqSX4iSDtZKUzOk+RcrFxS0sNZkcJlukLSwSkCyuaoKjPaFbZZS03CHSEeBQ5LVLhhi2W
WhLtcNnQjumgvTcPROgLd5pIiy3zerZ9y8/LKFskSdGTtFyUJLVmo6vhfKwI8N4WeTnQ6rOSUaaI
NTOQlo95YM95JdCrHKv0WqorxHo/XkRvknKOOFQUDJ3rnCBsvSGrCgbskOScPoJgICaiCA963Mon
zThmN5nWGBcR4FgkFhT0jT4e+p1wQtVw64E9udDc1/fA5A94TxucBSgZ5bfI9SPeUVfWeM29oAZ2
2lriGfrA016x0Cad+rQ8pkv/zjclvePdAf2Tp6wTFUMuusrSG3GnZ3G6aCM1zYCSbFNaR+SJ3hmI
lU21ioxZNWEgvF48+ZTOz47tO5g2WL2kCLU3U5sdyfzfJERL/oggIMJknAlcXq9HaRRMP63RN3a+
JoAxtrJhxNoB/eWvHER4PmLzrT5+/A3fWaywqRZ9EL4jba7VkHJShGUVpsauEAbDrQPoR8o0iXtS
QP9I/vPO20FPXwjlS8xMnfH12xEZmVLaSirF4rZ9ypIgv1SAePWuVWVlbteFUXdHYr9112YJBiyS
BvQ5F4oVjMnXY2pFXU6YU6i7TJ4rLEKnWUa2t8qSy1oKq9N5yMvroAq6H2qrAJfT50i6KvpUL9yP
p/mnL/3qcCSbpihInADCap3sUirXMnGO9V3fdlbsJCPRyKaV2upKEANVP5ewEc63pla28TbqrMUq
YZS1r22gWOJGTlo9ZgflPaK2kZncx0FYFW7DDVKcRLEMF6VN69D0+lhp7/M8wvkginw5coNeBRMu
5rN/U8hS+iAJUXYODLypHpU5qZWdlUjjRaYbCz2qUTTdRUE207eIN/vlRkhjpFcmWVCH0zCpWtOZ
1VodUCqajNjRzEz6Vtd9+4MAtCrOQllD/Tcd5OS+EsIMiaWsNQwvSpviWut61bDjRhBRK28Q0PYK
uVW/IjQ1TE4k+m1mV7nElAyTYD0uxnKjo6ljUmNv1gvmZmRnDI7Qw5hGUlfxL+ji9MV1DIcQ5xyl
t7AIo1KmbZS4QlRfJQmU7KwyZd8D6zo+ScBx24s46upDP2hKYuuhVj/FJQG6kxqS8LnxC9E8mbJo
AOFnadN925fdbYmscWwrzSzdKlEsfJ9qWf0akvTVWykV5isds2uZjxmXuHP5sjW5fkJmRxg+aspV
Kuk1Yl1Iu1/VkShgY6IG+rVfarFoS3ngfwVoPRp2H/vleStiI7Hjnfq7ous0/0LvAm4PTY/FykuL
OjvvcqnE1oF61ujUyiDU3qDl2dMg0jjYKo2Z3o0DdgaeXw3dN1Xsp2DX8TtAuklNKDmaL2pfzUAC
SKkgFJOfhlkr5phMjNhrBEVC40JXOzmy/Y4H2jRZYFabKCcrvUJEqehsNOQkmarv2HSOmSJ7fiJk
8YSatiwOsh0qPZYNQRbKu6QuC3E7ylbhY8SdNYobVIO4MAUT5WuhBZplJ5I0GA4eG322N4Uy/Txm
3fiVEHI+mYwEvFwuyThLaHJVK5vaHP0vAeYTX1SlzaQNstfIfxm+KOReMZnCoxCIOkruTVpflYQR
RBGdyGOwzgLPFFtgwPAOh4YVgqGCO6RjpnoBl+SP/9knI8qLcaVwfTbLr5702rKDKSqP0aHeuact
7jn8y8hEsZZafv6iphYrpVUJSIztYGvUof1/OTuzHrltbl3/IgGah9tSDarudtuO59wIGRxRs0TN
+vXnkfcGjkulXYKN5As+xEGzSZGLi2u9g1SzOj2l4yi+ymgc0KCyZBFIjAQWbaI23Hv6b1xgqD8t
GofAHBBmWKXSuaGEiFJVetASJl8lfYVjnmViJ8wt4XQd5IhxzI/nIc2W1STHqWuNEq5moDdKj+sD
+cGiSq52cLJUblC4KEbm/A3Toyn/exxht24Xrme6Vyh3Lrfo7foikhctqYIeTFlSg+2MrenSGOr8
h1W5zgWlzW+Px7uf6oLhWsjuMNxAUKzGC6sQwxkxWMEc5i1uEj0C475XD1X3rKQzMotKY83jWaBr
vldjuN9KWMBSA0O/Z2Ehru9sWkNaXCtjcq2mKPFOZesYfyOFryZ+rQ5ufaCwXnSnDi4nnpZCeHtv
z40yHIVbGmrLo4W32frh0k4gtSY7ya+YDIgo6BGOrP0iLsr6YETk2YhKUoJCcz1ujICeQKWce1Ma
OfFfbT/hGFWkv1x2oeFGTYuePikw2+D266dKXBsohKfXWjZ0i71Ges9Tg2pgL2P3r8df/n6nMRZn
GXVI1cGSe/U+rCJ8TUo1S6+Fa8DuMOL05Gp690aYA+aYbr8n4Xa/03iz0NhnyalcI399O7e+j003
zmY3wHowvYDbcQ/oy+dvjGTSLnEDl3pSjWbnJN/nhQzqalDpmSOgidWgeM0sBHzDC4jc2SsXOd4Z
kz2fog41+8freR+a0AQkYLAnbKy21o0TGQnbaa3GC0qr0s8KGm9PbTLt9bY3vhrKg5yaH4pHbL/b
VdTCmcdC1QGdUROFKyRUPjRi6E/xoA6cUk3sVBFWJJGlSkYmDzKCDh5HhWr87YDJOBvDyKuN2rCO
q4khXMIf9Qyjfh6H2nhf1sVgX4c2bXJ/QBYb1X+hibfNIJ13sWKWxsEdRhqASSiVj+HkNNFRa4w8
e5PoZmEdQiOeu0tTWe37RG378NUpJvNbi1zupzkiFTo//kgb+4F2Pa892ngoOa17zvGkk1pabRhA
0VscZDRI0CcDSXrnMEUWBgW/MdwCRODSWozYVs8SpYHcOIPPCaq6c38YoOQQMIxafjSzvFR2HrIb
O3ARbUEHCzDmEldvP1WN6LriCC0M2hwZzzzq7W+dnct3j+e0PQrM9kW2Bd7DKm54khEQ4QyD0lYE
yUhqJN0ndcRmdWegjfvBxfyXTiv3xBIQb6eDem1f22YVBkj/OvORdFkn+0NgVDZdbh1kaA8n/GKw
0ptm1HUfz3JroyzlAJ6vbHt1QU3+nOfg1ocTbaOHgYpHz0cyolb/miZG8UlXpFl9/PXBKA3yyOMN
C6xrVY2MGjcavLFXAkW2aGkiuJkcyrpWr73m7dHMNwIIG5/6LvAHsow7cAzS1qmpTUoQZV6OrHzb
HhGJGs6IFf09cTx2ouJG1KdZATqTShoN33VUtNS2Hb1cUwITnMpbXa3l0Z7t7KVJM1gBVa9cpZbb
Oztn+Ti3+RtoEkr6XO+Uc6CW3X68thftyN2tBHqVo24Z5aoI/bTWGuvU2WjqHO18sNHjjovhL0UP
XTR2msn85dK2Q6EFjB6zpra0LuCnxWjnlt0pAYXLXAsExoCa30fWMJyNrJ/U4+xh/ua74SQ/PN5O
WycUg0Pzf6pJIFxup89RFH3X5EqQ1bP9nCNB4kc8Z3fmtzUKTqt0Zpd09X+sFn96CTTIEVnSLfmy
2Kg5h4E+nIERn4dh1uPpbO1YWJYkaLS+aVCspmP3nplaoWA6DtWkxGsr34v7f82ImquM8j2I7NbJ
51gsshgc8rs8pfXiJKsM1wO30phH0ygb2k+tjY8tnoOPZ7ZxOOihL71XwGNslVXAdi0a3HqXhUGX
toC4FnO/96rITfCGebcIsOKVhcVV7Xk71+DGkhJPERIh94UncRcESrZ+OzPHLmzbgLIsfF5ttj9l
PfUZiq2/6EmyJBGsJfctxnUYTKzzWiujqL48JoNMs8aDHmqYBAoX9Z2paXYC98a2pMlCGMWMYCly
rs4+rfzC0LLaC6rEil8zvRBPnd0nl8dfbmOTLCkYEwNgyN5fvuxPmz8CGjCUZPJBlGbjs9sk7Smq
tei7F1nF8fFQKxHmHxkYdwNUdgTTwNivL1w9q6Q2ZIkXJF5TXk3qK+dx0pPl8W1HeFSa2TFrw8LP
og4sXdP3hwqvhi/SmKNLiOHdTv1z41pe5EAIaMvpv3u2ZRQ2cjku939TpTQK3RJx4072TxF1ND/G
SucUS5uMjwut3lmLrWU3DBoF4JF5269jagzIy+lyxqbXIpOXwR6BQ7mFCXYWj3L01h8v/eZwvFEJ
OwTwu8d4bMRVVxgW2aLiVVdhj4Z7ZEsM74ZqsvYoo1tnEjuNpcWFfwPb93ZLDXjVDW7PZ54dAM/a
OCqYS+rGIQR8gYacumeWvVFUJjOlMwiUWOevdS6M39mQFVbrBfhqtJBBW93I/Q6Tp/k04dCqnO0y
jJJnyvxNeskjrBlOGNDENfXQccp2DtSPx/bqzuZXoRYBFZw32zpEJIPZmIlrhkGTDMiUeRRh6idZ
5qV4K3E1m1HcS9zwFM5KP6K2n6bPfZ6M3+3J7r4K7GLbQ91lNqIXY5xo3AtYbV7UtnOeJsrqw6EL
h3pPYmLriy3ZxY/S/NKZvP1iRRhHozqLMPASKb9XnhF/U9O0/AZeLpuORdJb+s7+vz97PMXolJMV
ezxp16HA4ZxbQstdQAEzPu5m02vfQiusVURmsYI7NVUs0yOgHPPD3DTenvDHfWzFhIMWGVcHwu93
j8/OalJvDlOXvGpxbkAZKHHO6QjAb+d+2h7IBOwIzIZgs7oYBfjcro1cJ8AF3L0oIiuuXWvuSdbd
H2+mwy0BYI1iC3vu9vuhyyjttGwYJRXZWZt785hLENXgEsed7b05IZ5AUJSAIwJ8vB1KTGUnQBM7
QRYCovFA8QeV3u9xHzcnRBpB4ZCqDlnZ7ShAYdW5mWwHeyxZHBtPQ1ayV42ro8hfz5JYO57SFCMX
i6z1W1M3Iiseq4FSP6HCdwt1OlWeGP15KrWdLGlzVvgM0W9CGA2e2+2s0Mp0FitxJ5jF+EUDLARc
emgubloNO1fb/YFeEFYoRJIz0429u14sUIaYwjsAu0qsJ7UCu8Y8HfzRK3QYScb/Ku79n0j0jfEA
FAPmBAYInGxdWwkFjh+gi9ygKG31qVTDFGtfdIkKfHB8zR72Qv7WeGSbHCp8o1zgo6uVTAtB4tAS
PpxEfdfR6n7Pu61uXkJsG/5RwzLRd15iG98OpgLgTQB7C21p9e2ioZVph31lIJRuOsQlDsF08B2M
aKZqJzZuDcWHIzkg1dTu4FxOW7bgxwxUyorZfRJW2xxpAY3Hwiz6naE2TjNVQw7ykgItKeDtOqZe
bdgtl05g9FRp20XncpTKsLPvt77WT6P8uL9/yjENLQHHOzVuwNEAfOnpEz2/qf84uVirj7ltnx5n
O5vjAaJH8IzQTtJzO6uB9G2im8u3KnG1NYvSez/Z+AXhS1ucTTPBhvLxgJtfjIKphwgx/1tvf8Xt
HWp8pRs4fRidnMbrzjaAPLpc4x7nY/kit9kFRWAYqksbnSqwt4q/nZU0JAQFaylV3W8rGlOpyY5M
8zn1Z4THAvzRAQHCJzhaidT/fTzTjRye8YEnUAUBXEe/5XZt23JOhWGztoOTmFUQa1H63avnDkmn
2HUyP9ftpnw31anEs1nqTk0CZDQfcltvnipKZHSbB4H16uNfayOdIBaA8ISNAqZqnXMVcko6ORoO
dSdrqg7gBbQ3iQydv7qubgaftrO3eEf23X9abdECfjz61imiywUdhRIbfL/VfssXaHTtkfDaEgPr
McPfHrKvcn08ytYmY3MZ4MYgMPIDbldeRI45xgptByetp1fZFckp6UFuuWP1z+ORNhLqhULNTfWD
V8R74XaoliM1U+BxAyAP/duhAKzha/Q5bH8sMvsbqgBJecDgebiqKo9tTxvo9rbKXhNpY10hMiJw
Sk+PB8W6RdAZsQENZvJwJRDpa5dW/aGfil+G5kP2R3EAWWOg7ODGVzta2maqD1LzgrBI4vBHdQQU
9uS22U6UWFZtdXR/KOlT16aEfpeliTxacBVRGEAyKMNj1ihGfZSZTD9nWWjHT0OS1W8MrVX3ivcb
8RB3E4CTNmzL+87HJOm8F2XG/sxS7aVltZ9GR0RvzEi2foFs1eU39s+CNwTax6rSd77dP06pkyOm
GlUS5Bm/pW5YvbEb4dIjoXcghnA8WTE5KqRU79KkSQ7tCN+8x7/E1qRpH7B/IPGbuEve/g6j2c5z
E9PF6qSVfhsT5P4vtpMnSIEVOHac+Bdzeno85sYRJQVH1ICGO/fq+uKh7DEYucdFhypz58tZxAej
9KpzIqc9gaytoRiL0s0ShsmSb6dnWFNXdJbgjgPI8CmLPfN7Q3C2DiK3onpn526EV7Cq/3+w5aD+
dIGr6jAW1sQrxu6EavqIkqTfujlrriPwsQLTpUh7B9jDdZB1DrMxeLyqW2GA58bS2Ie3hkPj7eg6
vUfTmxQ3UPShfI3NdHiBKaDvpMxbC8obagk0yBXzDW9HUVPyiaqbCK+TJU+mEUf+ONnmCbX8cGc5
tyZEpZQW8mK3dUf7MEU0z2pG1hV2SX1Nwzk+uoVR/sYoQDCX1/XSyL0DBbQJHLsitQOR5eIyp3l5
nOO6Oj3+OBuUG2TZaQuSFqMcSfn8dt0oYI/VbOd2UNZZBddOa/6YDMU7cMCp6Zmp7eNZKS6VPsbH
pgrVgwLV7QXwGE1Ls1OOqjJoB8ep5WueROUhnBNr58tuxV3qhPR9eXmhELL6DcN+SRUF5FQv0Ttf
LTEP0Y4ntRDqacSOdmfZNy/Pn4dbHRZ4lXmsRpEdVH2v/RW2pvEvR7XPz10pB9vPpZkGSSXKjxnv
Tkp/dFvN41gimbzTbtja0YsV+g9nCty6VxGwNHXUOOzeDhTMur96Qot98FvR29QqxM4u2NrRLkkp
bSq4KCAxbjcBX17YhTs50DoVwwdVMh8jAebx8V7bCukU+j0KVRTg79JsYNRD7BJmAiEm5yoa3LIM
wFqUOcriXW32YmcBNzaOwQbAlZiHhHZXIIb0VrWIHtqk9XP3HPaIJsg5V15ZAUxgLasAv9r8RmCn
9W2QWlPSoUa2aqHqqRdGrsKgRpuFh7So9OMwKFagd9aex+vGesJBADiz9E44vOudKuYe0QvBV4sr
z8eUCredqowuwm1SHxJfe3z8/TY25M14y5//dI1kajcnfZI4QWTHMRrkuv7qlM3IC6He9TLkR61y
LSrBwFioHbGW671fjU7Wgbe1g7xKcowKsubtUCvDp9IOdya1tYhc9gs7F5Q42fntpFBbb2qAXdF1
KOP+EMZDfZKN2z7P2GP5CfDrneRqObXrmQFfgXWJSMNCJ70dr49zxZiNNroa0nGyaxv2xafFy6v0
09IY/nTt0ctOVITc6ECbX39u0z65Pv6OG6ed0gboDHpTMC3X1blWjCr3rxtdu6rRTlbF4487qN45
7RtJB6ELNjIyHgsWZLVbLB2jnLo2IpKMtnpBzaN/Y7uz88aRtv0ShS0GvKxQi8pw60V/PJ7hSrV9
aVXRxaNHi3sBVr9wr29XueU9j+1tIa7CKb2aTADcNd2g3DVfumYAYqzVJfXBseI1iaZLIzCyyHo6
nb2SV+VRDzvzIkfbnM+LKgN6uW7idJdBcd30aLmVRC9BW5DKzmDWexSCrYXDr+WHWjTrt6aBdKDI
jcryAEZQxhWoFCnOOeyEeJfFc/vkYQuEy2qjnlA3dXfuga0TziVAp2kBdt11E0OnDDO3HZVAzdXh
6HWzfglzC/nWchx2NuHWOQAktOglkEXdvzE4dGpezCjQdiL1LjWIj9kH6Zy1f9qhof/p9ob2bVRM
ECixMN2XVOMFtMOf3ZouWmHYr/DP+06XkXmtNONOXF1tjNEFlwiIO9E/DfbdO1Fm4yoCNcBTRl+a
3IjB3O7HJE0i1ZxigDWY9mKYHEfQpOJOkbMvcsCRh9722uEUAzXfU/7dCHDUe3hAUd2gW7MOOPpA
XdToGyUwqF/jBt3jBnOQfcmbH8k864/GFF29Q+/ZWFiToLpAWhd2xrrWMYpYr7wkVQIw0p+yui0+
qVn+KW/dfucLbq0rq0kCCJYIKYDlz3++khyrUzS9DIMsk6M4qErOawYu51M9OL089EALClATZb73
Jt+aIWxGngF8TjoPq2tjUrW2a7OB5nPWCqS1K6VQD3D5EuPgjHLPxGQjJIAV5OsZXBugo1e1I6dT
Mq4S2s1yrPTo4rUOdFR36t02KBNLluhvufZ34WTRh0KJmv/1avw/2wObw1PRVpd3MZTE1e5NlV5w
XN0QgIaufNK8HD5P5DQTfi2kGeNLB5O3DEw3KeW1node+fw4nG/EikWnhuo9PXfO0Gr6iBGV2iQT
cU3y3un/hU/RiqeS/dcfZ32A+FC5TlJAf0hRzepA/lcHzWuq3yjsL3B/MCQ21qB3UDyAcPWU4m8c
KGMTPWdulxzcrIMq5ET5zgHa4IS7pktDeKE4sLPXz9mycLN0VhwlkLWtRG+8yojUM/IloqCGZpjX
0ikrCIid0qCNIGw1b754eZSMvqpHmXOu+1wmFwe+5JM1Kkr3PCjK9Dp29Hd2XmdbB4EvQ2jjwr1/
pVj5UKmejBTQ1EOHPH+VRn8qfS9NP0wlqkaPd8JWMGMT0nommPIxVscuT0OUrlIAiqKweRhZdWkd
TFfMxjUyquivmPMznR8PuZEtcSMCFtd5e1ITWoUYchz0DpD6uJqTlp+byinP82Drp8ejrMTCf2Qs
JCq2h8000eyuj5m6GGSXrkXGglVo/m8dpVr83FjaFB+kPqfjITb0yHuaWq8YL53qzMq17AYLdgvg
reQa6UaWfKlNUySHSRpyeA6LvnsVQ2wjmG/0leVPc7I4n8H3np70xKnkHzGvdfu7QhaGHG1ejWQ1
UCD2dFo26A0wPDk0oHTpBt8d3wFDoRSAa3xVvMzwrpo9OyNlBKAueDVMXvSmS9RK+nqIoorfIbeF
g5BlNvrZMJTstfJSqG+PV3vrm1Ir4iwjYMozbdnUP10btqY06mDY8VVzwuoa13bliww43+NRNo4G
eQ34ZDDr9LLWhYu61t1e2m58zR0reVJJh9+l7VxdnLjQvj0eanNCwBv4e7HXW19Hc57IWM4ssY4z
+mUEeOFr0A93lm3jtl1+NsccugwZ4ioOZ2qdqlQt42vbgetWHFnjoyUBE5QVfLHK1Ns3kSaqy+/M
jUXUqf2gtrK6fbK5N4q65QDqkRbhSDGZSnIsazfbWcONWw5s58ItQHUCCb3lz3/aFOHgNqUdZck1
jQRPIuZIkTJ2dANjk7QIx4sXunH1StW//4TqSvLrgGjeO0zQWogOQFtWgSaq52o0U/RazEnyLPN0
06/zunotpBoGRduK4PG6bsRSporWECQRiiPrWx3Nh6iikiquudUm5xlYcGDOlXGMJzF9UcdkTzhh
YzzqmQgDAzKgsbtGaoDqciAh1NE1T5vqlAlMs4YkLi4oN42BWhe/cTOh/gud1wVfet/Wc4wBOV68
Cq9TL8GDtFl1ngjlZ+ije+SUjZPOUNyAJgADFOZW1xKhOxlEnUbXxo49gHK2/lyrlXat0BO7Pv5q
m0NRrmWrLkCU9UsCzVMtK3Veh/0A23ROmuw5rCP3Scm7YYdys3Hcf3jwLugCduQ6uZ5LLR/6LhXX
GaXe4rlvQkMeKh6EuNLWMwzjSSRJ+NXKWzyfHs9yA4VHlw1cGU1Zcr67zalZaa1bdKev5YzW0wUQ
CUTO0fXKfxvR6s/pSOJ57uY6xLnXUCfkesG+2WfHjkXm20nXTb5iVOaXvlk42HXXOS+dzb842VYS
v0bYcYrPj3/lrQ8DxF6D4EX1gQrgbfhI4SaBaum9YKityI8g7gVUgbInXj57AoBbNWoKHOhkLS38
e/aQYgKHoKnrLTBm/TWWtUkiXA6nXo9KP6+FOA15M55qLIGOtRSqX7fxnoTxRrhE/YSuOakfN8I6
XDWNO8hElUvfter/K8uxf0IjwzyGSI76kxkPf7hW/j1M6n5nb2zcdbz2qE+AGeXJt24rz8IqUbSl
4Zv2YRsgDWK/c8ZhT3VkCylBxoJruoko+T1lapyqzhhVGHuk22kByV4xw+MUt50467khvwGDSb60
udJ/sdqe/8BMRMFbU5RleVZmkdoXp509sZONbgRRinZQ0DX0dFj/9WWoZY2gcw9WVsr0TexE8382
ns5IIk0YW0xh9fXxrt74ysDQWGi+MKrLd3jBwYmQfqHXNUj6Lp79n6PFb4W039SR/UVqxl9lAVzl
8ZgbcWchnmIjj0AvhLVVmtEMkAJkOgJAjozyWxPmmJy4CAlGo0OZdq7+VVPb3Il1G6eXo8vDgoO7
UPJW62obuWhJfSFbeMk3Kk2t3yA8haDOLI+PZ7f8pFUBmFRwAXPT3KZVsJqdLS0bOWeTxnZs9rGv
tDqyS42dVOOhrjlth9Jurf5YCq3+O5JzE/peLpVfh8ORh7O6fFLaZ+tgVcpM6eOagoJWKXqOx7dq
vzaOFUIMstu6/PVEmOYzLxvGhOu1ToStZgTSis8rjYouA4lSRp+lJRI/Nvr6dyb201BL8Pgpietj
pY/GvA+DuEmKS90p34wqGc6Tlg6/cRIp6ECWQ/wIjuOyi38aKUcbQk/CDs5MPirXShfqyywJDu5U
tr47Nubl8b7Z2qGQKYlF3gJzXadrlWFQTMvqMDDUFBE8ZJjV7qQ3bf7d0GZ9D6G5dQZ5G/FiozFy
3zuLC7VWm9aG62FbTXRoxzhPXnHxtXDSnqaKAkuia+KA+AQ+H78+UdJwwMkE+aUdebuwnjHag0C1
JJjdpD8tbg+vRZnjyFma9W8MRQWPtjLO3hzH1VlUxtieXAHvqS6j+dzRZ/UbM1IDrXP3KsBbnw98
MBUScKGglVZDtaJXKwDqTpCWQ/YuV7WIszc5fj9X9R6DYyvEkDjRFlzarXeZ9uB4RTqrNAYrs3Pe
1SgmXLvQVN8DzUc0QGuH5g3PrOYKsXT4NtCa2Xtfb90aYCnxYIdDShK3yoUiM1XmIbd4GIowVK96
HRbdeaZs8l3NovC/GuXp5hgNmfGFbCHbw/NtLbX3Q7eCwj6/wXoD0cOj7eA5gZNP+ds2t8dz5TZo
94Mh//Lre5XyIzAeOI4gcJdf5acg4JS1iC0avkHZ9eFZJsZ8rPs4fVIb/Tcw2nApqd8zEN90HbIN
feJtpTBU47nzS2Vj/N4CcvNFnYyHPpV7G3ZjE7F4C5gGHNh9cySykqKLZ9cNFvRvA/bLmj/VoBhx
NzPK6NtkpdxeskBTiUdE+TTpTfz98eJuJHqAEriSibIL82l1ZKaolbNRAhzSK8vxZdNmxx6V+9Pj
UTZ2C71C+pQgLKA7rdtthosMoi6Aa3eji4B2bWJVW+jjJZGpvZPY/EhNV3c/aTvaYNAHNqQnRO52
pdV5XtB3atoH1hCnRnFo6W38jWjY4H3RqizEsaHrMvk9UlrrZR7N+FWrQqP6PJuI8ZzMvnKG1wG9
ovE8tPWUfVaG3pHXtJ0cDUGnMsrf5JrIP5QVfZcDhKD51e6bTvGnQabzS19p6gcawK08KciId5d5
Cqd/vaRCZyMOG90468OEMSGY0MIfplbE1zJD6H8pO2tIOUExFk/TgJ+ql3lfNWeYxvcI83mNrxux
qQVF3GQfNJwt7UMDabw/6o1X/teYXQbIuWqq1k/yQkfjzo7bv5Sy1kNU0jq2kls34g87dafxUNmp
WVyztq97+gxmFYP58/C0ULukBYCk0iY7aXllzQe3cs3XxJuS9AsaeYa6szc2sm24fTy2OQVswPXx
nmQ/J91y5qhqKf4wJNVVMRKEsAprvvZ6Yf96osR4C9AJUaN7lZCYFDS0Buip1qA670tcOJ7aCuBV
r3o7Z2tr1xMDoVBRekbdYPnznwJXiwV1jdJsdBWWmZZnpyuiyNfSyG3OepwUewjEjXSCm28xWYC2
RbN1fZRrwA68nZWgAxh05nqMPlrTiJMk8s3HxDTNI5XjYee4bc6Rn7qIyYJtWp/s2pb4tqiw74t+
aK58vPAVDS37LUTn9vQ4iGwFS/jnCOSiCUWjbnXhNc5oTkMj6UsAWOnpCOkRRQtLxvgPKzJxj0Y2
laYfZ6r5BN0KMbZEOMae+9rWhMEdLS1XKMd39z7U9ByiBNXCSgzRJ9CyhW/O0v2cK3qzs1N/XKLr
UMYupXYOYhZs8mrGeSwdo0VdO5AkgtOHzivKP+mHOpgIZrEpzlk2D9O508Mie55jJXmJsKmuD0mX
2l9T9Phf86zy2quRWUpxRDQNt13VAtEEBUkxk/dxZHuFj6sWxvCK6OSnOitS1x+aVkV9rE2V3C/o
jfwFdiP5TKpaKGfI2NoTbkQZzt4uemwyCuPfYJstYvPeYigBLHO9j0dqcopm6wqqN/mnNDW8SzXZ
SDCroxE83lEbl9+iwcE4SG1zBS8n6uaAJrqHYAMnJm0z1O1zYm9ZxTufcauSRKmZViONGaLB+mlW
VpXpydzkM8bm+FKXBrIY1qLl7WkscVKY5t8VXPzTaKdfh17ECBZp3x/PdCPI8itQRQK0u6EWo3UU
MgtP4ZiiBhAoZpoNhzKu5hNAIe2spUW0AxrYOCaEPQr8XPbmgr6+XdpmttMha1AeSYG3H4qwz3zT
U+JLp3D3Pp7b5lckBybs/aiTrU5JPY9GYnWGEljY8gSoe03B4ElrB+i4NQoP6wXQtaiqrotCcVHj
5TKEStBEJh6jEmC83oLhfTyXzb2ygOQQUqWkTgJzu26lq8TuOFHAV0PpXD0osUExGubb3qbybXnj
/B89a9U+mL1nvxi5NYsjCDD7/eNfY+MqQVDFRQyPiE4NY3WVjN6Q4wEUU9ZPRxFMsEz9vpPJidQU
5Wdv7C60Dffk/rYGXbBKwA/AlsPGuJ16TWcqN6OBLreI0F5XlfDJ0JriTYaKJ+YJRf2H3tXtToVh
41JBNYYNSiBYTD1WIUA2dWyPI8ImkYirzxripKeorQEpzkZ8HBWZP48Q1X0xcnNqxe8wMBa8CdZV
PHDuqzYqGlWLNhvnkibnm6KtiqPmVd9Dl0rjQrr95aNCXQNwBzh0mHh37a9Ea7VK15swELOjf3SM
SSx012nn7N+9TBcWxCLgsgCd+Xs5Sj+F1Umv27qlqxF4VeO+l72s3nae3hy7rHNe69xwIOFVgBLB
L/3yQ4OhIZUsWo6Uk8npb4fG1CxM8HPogrEXnXqYbVH/2YTzPB2cwgr3KPL3p3WRDufxTUuKdi1t
idvhosk1Z0i2Q5CMXTQccitDxpGFL9tX4famctQqCqH+XFTpBN+wyvRDpg8FObVlJckOnmVj2Xkg
e/QsOT2LUM/tL5Mkra1GSdEz9wJp2RTgfn6KWI0vSd25X1217sxz1BjOQFPJ4jHxOGZsDE9Feblg
SI+4TVdhuJtRUx3o8AekLYZfthSWDu1sN4cCv9qXpgDVWWWZ86R3+ZdfHxmi8/Ky5C6/a1Z4OCZR
ZJEDF0Ao0Sipsme1MOvxYObFcNHmyH2Wsu6OQKvD6+Ohf7il3KRo6D2BbSThpkVEurLaASiU4QHi
WeyA2emfUtma6XEqQv2o92K+jFqjvFRJZ3zzpq6naxQ350Q1wkNtN/PSw5QH1PDEP11Y7Kn+3EXT
RYiKC59/gByyjSUj+OkQlgbEaJHofdANiv3ZLZDAKqrZucBBmD9KTxifOjMbPj1ejrs0g+KbRTED
xjkPHy7k20FrhUIuaPwuGJIOuWQl9JLrpE7Jx9EsBuMkEdYtdm7Mu3t5qfeZCJzRsVn4/Otdj547
7sdVH3gF715Lj6eTShn89Hhim6OAHUIMg8viDirWOK0Wl27D2eJF/rfhieK11edo5zLaGoU3GrcQ
eIGlR7JaPjNzCxlTtJCDa12afiyx5PH2OgVbo9Cwd1RQsshHrGFvzVThTokIclBUpeJXRWL7kyud
nXBwj0jiwwDLWSQj6O5Rtr6dTFVTqbDRGgjMwXEvnV5G8liEtvYuMxz+r5MM1BkogFivc1yW73Dj
LN0jOakBMzhrzeH4+AvebU3YG+BIUDEnoaGjsISvn8+DA4ff0ep5ESdI9YNRUHVBgFwtxcH2Sl2h
8T1O/z4e826llzEpr+EiB83zrsnWVqXoGwBggUJ6+q4z2+Y1r8JhZ29uzgyyLEwY7nUupNuZYRRp
WeitzqQwyPaWJiaLSRfXf9C+1S9aLLw9Kv9dpKcfzlGjr0aSRta0OuXRiAY3X30K5sxMTh5wthen
kMmH0RDVYdQi56JrZR1EbRz9agdxGZleAn9xx1BLvp2qHdMMAgWiBopSV2czN+L35kQvwfaUds+x
cvlZN5F9GYv7jK+3gGLXj0PXgKvZVsocAG02TzL0ppdW2uLDIM18j+14n0gwGKp38IxIfslglm/8
0+4c6RAiO4c1zpAp9Rdj0MUz+agbn/NB9t6hN9EgO7SN1f4zRJ756vbe+DZJqAju5BD3O5YsBt0C
+Gloa9wpRCtKItrG7I2gUFJxNAWwBrNr9vhA90u7jLLMkzIcxMvVZ1zKOACxEDDHZLf29Skb/MEY
qw9xR0ny8RG8Pxx08bHhAVYNnu4uv09MPQvTWDWCCT7pwcWQ9jTNjXtq8zw+DkAUd3KRu2uXeo0O
plhbgOTQPPTbD8mlgBNDJzBv8LL+gsNS/WdZJgiaRlUUn5IMB+ED+D5153W6taJL8RSZNL4ej+7b
YUt4kw7keTMA3SaOwJd6P9PoIJaKof5yIF3cYrlykYSF87CO60U0JbWKd1NQZ2l9FW2Xfopqe36Z
sXT47k3UsXZu+OUGvz2IAHC4STgiHMc7DVoLRdG4ElDiBnyi/kIw26mfYMCC0jaqvEQmFuF265LJ
HMMyyp/XwtTLfx7voo3lXZpcXB3EWK7/1fEM9aHJqrhAlSjUlEPnObjhpaF2ct3kl8WjKBRzOti0
XJn33a5pEpTuI7jCc2mIC0wh+zizNqfHE9o4FvAFOBSg9igwrsF08OKsvIexTAivHfoVFvoCldUd
YdNVF8wGsHl8POAqsNCeop6HoAMXL3AIXoW3G9ShNVpQds+uPDfdFytEw7c1xV7SuzEKvFAdEjxZ
6AJtux0lkx2+jk2WQWJIi1d8+eRxLt095tvqjC9z0fET422rQ36761g4Zp2mFXi4q6kV3SHrUu0E
0/9vp9fm6mBOCHIcItrDOyu4OgY/RgUlQKZLYY3m1uqa79pWA3ous+tgxcVHzDqapz7EyRIx1qT0
DmVaL9zKLgZKiw6J8S51aTL8zu8AVZS9uQC713g0xTCn0TTH7IqkrfuHZXALYf3j4EUfJr4dz/KN
onj1wZ6S/GtmyurT4020tfBgluhx8MIgCV/+/Kdbssroh/WlLK/03pD9mwbjW+jY9aGt+tbXFb14
A2Pm/3F2Xj1uG+3f/kQE2MspSUmrdVmvu31CxHY8JIcz7PXT/y/6Pclq9a7gBwgSIAk84tS7/Aq3
3l+PioE5TX5QIaRyl0D2be6WPlrb+rzBwHkUg2mfWn/pP/fmEr4pG/lvQWP668tjXtnI7C/amAGV
/+cprVXrati6SZ+junUe2tpo49wwq7uXR7mypejJ8gDbfyzao4vkFfkaUEOtoc/IkYbfw7Ys5WFu
Z9ncaRBnIlW20DVWL6L0Y1lHaD40fdYVjy//iovLdd/YgHuodxL+UNu/rPfPQxiNllfVZ51l/dfM
nX6uevVioxjtjy+PdG1W/yCxIAtwkV++krnVbFi4qfrcZtmA773wjpuzyNPLo1z9Hu64P08F9baL
Syjvi7xzu02f+5J4nL5MF9dOFhC+GX+JAfkzddgdkGfBftgtgp8eiN7z6lJjDXUOgsX+PDsVNLnR
4Oy+QSHV68+FXU/+WZR52aRUZzz190eDfJX0DtBiQA3z4k5CPAN4YTE0522URtqP03rGqG48zLWr
UkSNiXiWwbkR61xZRZAZgWNSWtzFzS/mdy5rgcHRVJ9nYTpHJxvrOFrmWx51V1YRqgCF4b25Cajo
4tMc1MpJgDJ9zq3KjWXRNKfGsZHmMozp8PKGuUyV92VkLLJEl0xjX86nyygrCpqmwWnv27xbTk6X
tX2MO4h6V834ch0b0Livhd9NazohEiJf29CYjEO3Bu2MdWmkbymoXZtiBEtw0oYzZD/TvFtULsbN
Wvn4adE/W3seYAhjonijRnB1GN5PYCdUI56JPY5LL1vinfos2757FLMMzrhyGunL03uRrv6ZXf54
YFp7cfiZ1m5bVHa3RK0+e1MknVhT4fFTR42ldRxEPt+7a478bjkZ5am20cW7sbpXPjJySQcoEsLL
YMM+XdwI0yth9Ft3Xlrf+Wh49XxvRaN9Yyqv7SFEaQnId0Y+taOLYSi/zuQlqjsLwzU/RUaXPTSd
GZyMzuqTRrpUerATS6ZpG4442kWJLZf2o2coeSOFvHJwaFzBIqWRY5GOXNxJxTJ29pCL7kxrXL+d
fE9/IXdukZYT042b9trU0ognW6W9yl/7T/lPPFA2xbZYpd+eRwr9h0nDKGIP/WVfakdwEIzv4jgg
8Yn8Lm4COKCZQaYsz2agkbSs2Gl8zRxNnFGeT/NIfbJ/J+xs/kuz1T8jE+nsDVuYkc8QxJUmFCpb
2FIUccR7Z4AMC2dvvMEufTaLfB+ICh4QKlTElRcLlkXdoENLlhBrgjHWcMFivba3zvrzDboPQwkV
SqBDgnq5QVUlCiLUrDiLqeWMrwpkdux1KmreTlLN2Sc7Hzbzfp7t3jlO5lSA8FWeNg6ti5FlSFul
LO3zy1fDpYbFnxnee0U7S5EE5TK2yxrd20Hel2fdrM7Cu2USPq6uUDSMFjbcwVTZem66egviPCyj
nw7RbxZDmjHLV1le7NX9QcrY7DApjBff6b9ZK4yNIw5b+ce+a6RGJUYWt+D7zw4Zkwk1HmAuLDpC
jIs1c8dJ55jbyDPSGMur0tfFeakrLPsqFd14bq8ORXABxBRdhWf3lxHROVPRJs9QNOTd1ud2vNQy
uCu26tPLq3FtpN2fm+QX9N4zEqJQNbgeMZQcNOXHg9MN5ypbHNjmlXF4eahLp6M/Cw8HkDRuL0Rx
az69OiZkXAWuSvJMrGn/ql2aB/B5nOiTAc1lxQe2Ut9b1uB7WZqyvPehIoaxJUbzG8yfrkrabnSd
uCXsGd94zeQ9DtXgGYegKoI6WexQ/zCzzLXiqV+cz3WIQWVsVwoI3iyc9dbXXJ24P+VKIBfP7367
Bd5MF7I8BzOuTQAry7g1uzaZqDbfiPiuXRak8CgYw4LlLF+EKtj+5RowZ3l2C1xRt3EtXoNn+ctG
yJ/V4ckG/LMbN1Eyero6oBSHqAqC8uyXUZiWOVowdbH66cub4Nq3cPJ5m+n+P5d0x9BzQ45mLM6e
Wr0UDy7nCBnrLz0q9m/hBqchviMAdyrD028pAPHnNQZ/51na4t0SIlXs+aP6+0ucUYgjQdkCXb7s
vK2GP2tnFIxirt0BcoY8Ip7t3Igyrmw0lJ2pgO1K1kSsF9dOZ0Q11T/JXaDbNTgEQvbI0S1hqGO/
wdHk+PICPYvcmLodYr+z/YihLt93qXJ06YatPNMzX+/GKdQg6yuoShHeqV8WK0cp2Sydf8yqvJVZ
7TvsP0XHP6tGiZPYdL/2nklI9Xng7wWV8lxHnZN2jmgN6CDW5twtmHq+sfJl/qzB//xG0jX41Zre
r5c//dr4u46tR+kB2uvlCfAzT2rdRfI8aVWvR6K+sINSWY3h2Y+kFDiqtd1jDyZpPHBjoQDvbKGs
bwRY+3pezgKKnHRyUVl7HjpX6CY6WFLIc25O6uQsPRexC57l/WCV+kMuy8K+b93+Von5yjZzKNWS
fhBJsssuthkq0TOSoB5ejbPnrEkW6taLC6rfABLBdv/9A0cSyUWzl5TI2y/jOyfog9zT+ly3s2nH
FnbB79uwFb8WZ/VvhXRXZvTJYPbT20C6Wet5XUbGPkr1yghLkSJebsZ9+ckoza915tU3DtFFqXff
yXCmabUgD8qVenmIxmKY26hx5dlDRneKZVXOH3uNBCu2vIUZ7vIyannz8u69JHb+GZSOp7d3PykO
XML/6h6Nwwn777MK2+0R8WuBHtOy3iEAhrOur+fjhJdsupS+hddgPSWlaLsD8WP3o1/1LU7AtUnn
YQSsi7UUOJGLOhe7p1h6OySw8Eo+2JzG+yUKm9ejyMs0I28CQyuxfn15Eq48L/tFSVhNyRbpz4tH
DHEbqX2jlmeMorfHoQYV05pG+OPlUa4tL50YeFW7aoR/Gb2jW4LN9EAgs+WhcdTY9R6habcfOlqy
7yXe0TcezWtnkzPCseS8cNQvnjN/IDzvI4O5dKg3T9tSHzwx4tvhq1uK5deHIi6nDsqjc9mkMBd/
wU1AybPf2V7stcuPxrW2ZMXv/sa7dnWp4AKAnKKN/uwKKPvCMCqQzOd8LPVrMzDm+4za2o1y65Xn
bJdZJIreqTbP1GYjs+vHYCbRwul7mx501oslXqJiaw8FUuUd1rTCsdMoW9rgXud1/vvlrXIpeLSf
SsQMuAlQiSG2uswaNrcPgn4jlJc6ROEOOK15JwwI2Gdj6+T81bGKoPqi2xqv25Ci+hwXxookdzxE
Qf1pLUpUWLEf7/pk80pXHzT2gv4xaiLrlhnTlQXhl0YgpnkDnpNCAF9qJ+84O31PViOrQr2iuHHj
6FwbhH1MW5heJsNcbOUpc6n+Ajk9F6G3nEhsZOxta3OjHnLlgO65JZsYUC+10ovHDFkVPe1aiWdv
7oL3VrYWD723FP+sDe7nLbH6LQ31awPuAjLUC/50LC/eswCYF072kzgbdd2mQ4HA4LCI9U1obN8c
mt+Hl3fVn9DyIkggUqc3Cvxvz/AvKk9NhofBXE/5eVBt/ej4W+7G8JtyL6XnrT9YczbVb8LM9CFQ
0fG8m8dtorzvzuu9v262d3RG3NNTvbfc/ilL5ShwAWW+pv6gJic2VymyZCj14ibjYltVLCwnFwc/
KhxJVTt0qMNAfDBirUrLSOpOSFRFd12SY2Wq+hgFpdHdt1noDHG3VKWTqjLo6FrPUR0cO2upi7+/
IymIE1Dw/pFfXs5IbWs3hNuHsMbqroc5xFUGBoKTZkO/3hjq2mLTVSUW51jvBaqn8UTFf5oprwKa
XqL1nGlbfxyGuvoOoctMCmnY/8vuopaJOgJCOjzsF9s5A2zuKoHT5WyNQSpq562wXPJN7Knut824
pQd37YzS8KTWz+W1W/U8/b5NSXPE1QhjTdPs08LxRNrgWHLjZr7y0gAeRZ9n71A/706biDOLNvKN
O8seTPgurfWqV13/HpUE+eHl43Ltg/471L6g/6lZwppBsjZEW6bHwytxDalOQY1Cz/8wCvBrigJA
JlCWeTqK729LPu00AlF1XSypi5/o4t0yRrzyoAFmBomFHtZO77y4QKsiXyrE7cU5CxxcEqRlHODI
Fke4hva98rv8JMLKTEXFnffy913b9tGuJQFKCfD15QkbzcGGjMEJG5e1SHqO/KmeKiuOJJ87T8q7
ESBciSApXeKgtwssEExf7PoIXCJ5aICOk7saj25vhUdJ+e+4Cmy3EJaoYBOut4hQVwfdFfDpCvGP
yxrVQLO1Kr0wP8+WnR3kvE3J2OXeGZ2OIJ1qb7iLqKneiFqvHAU0b3AIRCQL4l6079//7M+g99vM
MHpEQEJtvW2kP5DsBuNnY4qc48uLeHUoyCVAFnnmOeJPh8LFzp/CivdXF0V4HP2sipWhxNuwnX79
DyOR44Gr5QEGJfx0pFJHylMNMlWh17ZjYhWV29Bgq9U3hVfgLUDmJZpvj7NgPRDgcfZ4g5+RqheR
N4PM83M/jONrNzTkMcADHHf0UPgf+hmJs4Ontk0lbta73/FNb1+3m1K32rP/nx+yN784LLQWL75b
NG3Q1hUSzYXVOmlutfKEG9J4nO0Gf8cpMsgB24mpsOowQUqIWykbu8PLk3/lrO63A28UlCKSMPvp
5EN10LO3IFLdyxF9qTL4pRy7R+dGehRW/OB/2MAOTT8qu6Cbqew9Ha6qZ9fO6t1fe6/vpfUyFnC2
hvzHAGj0llrflduc3USfiyoyBevLpsZSb1hf1I1xV6h5TqArdferNM3zyzN47aDs4MVdshKZ78tH
cFWtP3oVjMilKfop9cBr3a0Srks8DYXz7eXBri4XeRCiJLsC1GW7K59Nv65taFj5NLVeooealcss
uiBlbaXzRl5wY8WujQguGxUiCl1Yo1/EMI0bLLwtEHuBZyMeHrpqBMZQiuxtZfjrkHqVCswbF/q1
haMwQgt/B4U+g6C2jUGiVo3iXBYlx1C5Echp/9Yo125wwjLiCioPz+vYGYQLWnuE4p02RoAYPo6q
pw4WzxHp7eHVbiaHGbOTe6eX1/DKhtlbzYgOQoOCAXIxo9FMcSnXJtvSK637PK+Lg3TmIM6ADdxY
vEtzk/2y83fgwt6Kgurp76v7nwcDKeRtjcqpOE853usnW2VDmypdZVsyznZnfM5mr/WPjrJVcad9
z2iTTPcgY+wtAxpjlmb4wQxz+qhCOvWdHNX0qVJ96R9LL/PMG4HDtZn576+9uBE7Yy2roVcILgAc
Sd11QtFrHuwYn8G/NPz+fxMDXsxGwhoLm8vEr+pL+nf0qKn/bNNHc9nqpNa0jh2jbx/qsXHTfhjG
Gyu/r+xFMrYzR4ggwVbvDI+nq4EebdfWHTFDoKPycZitNfYNK09G7IWT0K+MFGEA9xvLY6bTGKnH
lzfelaMMKmdnq1Nr3J/Bp8NPde4Pcynys29rR6eiq2icht6g7JNYcCuIVzMYb+VAV8JQ0gNAUAS6
ZCWXebxCpQkgJhLzkWEXr6yx7o/ePMt4MyqLTUSJ1cIXDahg/pd8hD9LTHBGlETPhSL5xecuoiml
DQbzbDSZ/1AHZkPDL7cSu+yCGwt7bWZhIiAEt4PxaIs8ndlg9cHqqb0XUmZ7SN861kn50j75DZVL
YbbbjZNybVYxlSArAn4AVeRiwHJUpQNCsDznYhJf5l42AK7a8tB51hrcF/0Y1TFXZnQkezfUjcH/
/OkX+xgLRwJtcj7ArpelKm+0MrraLTM75uUIm85w27TSk5nfOyhBdAdR1hP9zknkqTOQ8tIFyU07
7pxQPxh5P38SnQEsVgq71w/w8DovaYSV3QfOOMjHLCuGx6gLuzcIlWIS2TRhsx270Kv1jRNx5aGB
gwe3gxsSb7nLzbl0eeuiz5if26ZcHnBetEQ84stzfPngXRsmomdCfkLD6FmVCS6IRJatys96MtbX
4YjSjHaDW8qIV25P9DTREWALIjB7GU/6vbeN/uyrc+O505Y6ookQCzYaEHIuZeHvL3+TfWULhggT
AfCheQqC6uIZm3C+aeTeLMmcPhTHrG9wfQehZX8olDuPiZ83WsRs08E+rfbalDGihRG00x7P8u/K
9srtyHcUVbqW6/jLQQhrS9zF7qq7oA74AxZlIMs9RmHWn+pNLI8z1Iz5wTVzMX8YfF/IxNWYHCRj
mwnjHpnPlhdrGqtXrhj1I95yW3tjIa9MMfQmlEWA3lFkudwvqEOoMRgdRbSs1ZZk7TSfHOHmzXks
+fuNMOiSv7rfYBhHAv6B8QNJ73K4rdLDhOUZU1xMVpgg/lNZyajMTsXaq8SY5Pagvg84yjWvTfi0
5qkRRjnHvggoMIEr7cPYmDprpD7vIFY3b6pp05f3wbUpQfEXXD8xPeoAF7esNi21LRN4e12GrL/Z
jEdjWfvYq6q/FAD8Mx0w6YB97n6az7obg1vnOTYX1Rn1SOuIQtTwM1OZTkZ707///quQ1IXrsXdX
6Q89vdDF3t1u0MU4m0MdHlfp+OmA+EPiS/3x5ZGuHSPeJwBylGfRGXWejjRncpRbr6oz1ZjvlSrC
Q4QkX2yiJPHoRvOU4G8h09lqym8vD3zlUvpjibLbagKCuwxGssETpvKYzboemoOzrsGbFfDX3/dv
d6kMqjKoHyGlcHFLVL1b6b7r2R54WN1t0mgO+YIJkjFat+Su9+jw4lViKOqRvExAlC5DumIwM2WZ
JR8Uivw+V7NOOp+MrBhXiwfIyJOqMetPL8/ile0fgYBghwBHeI53zobdFWKCOlOsXQ8Yqs9elRYu
VnVQ3ACRXNkoKN/BrthjjOfiI0NhRx23sTzPizFt58hGw/Q+5zJtktZZYHdsZb0sbyegpv4HIUI7
u3UdXYly9m4MlzIPzHPYw7B2yhS1CYHHdIufmUHNHoPdvPxo+VXVxn3gq48oGFGpRQ+t9N8bawPR
piPi9ePRc4sHe8DY+DRBU38Fxgu3zWYWwo2rbFK39KiubAaSHhqTvIjoaVwWlYrAncZS0k1rCMlO
yl78uDbldld7zpZUivg+K5bpBgP26hIB0iSbpL5El+HpWQ6bejazYJLnMaicb1ZUV5/WWs/k5W5+
KvtBvlbML8+b6Z1f3obXiklEGJxinmMy5suhqR6tGoc8ebaDNcfbWMFPjWGqbGVSoU/dprw0VYXK
Qt3oZJqk5eD9FTrwVqfWeP/yj7l2JqAA7NBxgkMalU+nYdAOuXPgVUjy+W0Yk9/bXwvhtrufhTks
h5dHu3KPwZKBJEMtdg9/9l/znxSXLFvldcMDBPQvgObQo06H6Fb68ijXvol4l2rETl97Js4iiFco
HI6MUlnBIyBaJ87NVR8E7+KND7p2zAhGKWi7UNieRYtYssnWGHwYbF4mT71SQZE4Sx58WeScO/QL
Rv3pbz8OFi44IvBUBHNENk+nEKVUmMxRqc52haJ1HLpYvqFH1wxeXG/4Y7882pWiBJEw3U8Kyz7X
2SUxRbuUAY2MeyScQqSWx7pEYFcrT37GaZlMxlV92CYDBMHmMarnXMRZFgEfXzvPWE8+D/FKfVhM
2UHPfpkf/Nad9aHV9pCh8uK07l8vCDKu6NXsUQfktsvszu4Re9BoH5490EeHIlq8e082eMWGtnwY
omG7MZ7HdD99yGAJ050EowN16JnDAXi6hrpLXZ4z9FQTwo4uKUO07rUzBXc31mJ/fy/HIvqgQEox
CprHxfuMnBImUtZQnblU1j7NxwmVan/X6o2h1psfa9L2b1nVt/VpC7piTFboGksMR7UUcKXbRsbt
oHL/Faj05b5aRPQLEFM3oo65mPAYxDyLFKqrP6dTOfMa3/j99vPfT0Pkj+ggMFGaqU+3brAhDBq0
AKiKwOreZZTbfswZcR1UT3vzky7z3H9JHCNYUCriBpKBW35QUqr1ta8rhGNz+DTFjaDn+QlGu4P9
DTCGwtszAWfmc8R+a3+qrbr5aBWGHztzFB0mNVmfmnH58vIkXBlur9xz4RJjPRfiLgxznqupqGDO
kY/kSDm/HcsNQFPkU9Rxt/IWa+b548rRJSoGEBBewcqULle8IT2wP8VQvJ9zMNmLaa6Q990Qv8R1
vAO1Wd6If57f82CaUanGq4WAlZ7605WGDVDDYZPTuZFme9jCvtrFd4MbD+l+xJ5vKVqmJLVEOfDn
Ljtfvioyc5JVdO5F5+RHHxaLeKvXwDtE1mrksZpxfE7mfAm+WcNc94fcW/ogRTZhWmMVGtMvnCm0
vdPS/K/D4omHJqty9dZrewymOktN7WtYJUOfzHpZa9rMXS6A9NiiP2VrhgJUK4ZletfPuvLjYsN8
OVlkVmHJOpqqQwY8iP7pzMr46raeeqd4ZQVlPDv7GgqRb7FfEValwA6N3xtyT2uqt6l+aykx/LOu
S6VeR9uy/PSsaSqhRniTThwJryPhU/IqRoYMITUAY/3n/Qjn8UJZ1Du2g5evyRYFq3yHfFP10dRK
fg1Ku/5qLVvZnXK76j/nIXXtg1Vs2xZX3TxjkTJmUv6LbkZen0dqQ0YcRlU+x42H0eWHOdMDrgpw
I6V7mmef1klkjGvzjygcaoTr2nrvDbMOfxRz1HqHgjh8PtnYVUlkFOTQvZYGrdLXCrqUSEdvqeSr
URmr+QrQuOP8mKqoMGIUZ+btJzeaRIKorWzg6tams6SI1uqNsn2DF6/rGrRvdNZ+UJ6RiQm2yBKZ
v7aljTS27e3svCmdmt4s/qiLaXM1B4auujNGwwBTf9lhPvoJOCy9EO863i86C9p/RQK/nuS6tX0y
7gYidwsVp+muCqfqV57Z41caxkQqCjjDp9FEl/huqfgfYlCWs07LYbWXGNm5ADcVMPcNBmH53CYA
iMTvUDeOm8B3LLd41Kr6Xq9ihtytxEzTog3D96i9WhWIMJV/ab2saaGYddW3AZnLKrHDnph85bGL
wLgB3DvgyKDaGDSPtcVqq4DqVJ2OwFzBmP+VCTSpEssC7AEcX6wiBacWVSnl3uUz5ujWW8KY4Rsg
okEf8qaX3WGqxNzFHQZgY+yjgV4lYYT+adJ5W/+bM+6lKLDJx7WPdBEX6+C/NvQYArULaDyq2pJW
QiYikzJr/DGZorx4NPoOLVQPkdkxhuY/vpJlWNU4ENbdZ9HK6lXpOfpkaNX8WB1fRSdbrlaT9pgJ
VEmEMutjMdR+GRvanpaE7S9LvONc04m7zQv+tSYn+7phH3Zfl0uxHGDVYJikzcqp0sHknXmdt60N
uUQ27n1OvbqOzWbuX40Fck2xDET2aG1m8TXiCa3Qmi7Eh1pm5UfTa7fvuVH2W+IVubUmpZ2Jn9jD
5EZc2FNVJBKWpYgNvJnWNJOBDu8aa1g+O3brvIuayhnjohby8yI371Mk3HFOtnb1344KZGmaF+H8
s3aN1Y7HqaZ+2YVhncPgGh2o/31TomocYOie5vW0jnFUb5PBvx+jQxmOXYb8fl0+oFopLL6sCNoy
Hfvaa1Nn7Yv1J7Q9jnIfFV6e1vT/qjtjaN3XipbZw5blUapgqKNkghPfGgM7dLdkmKD/pjXNPRUr
BM0SVfXze8Pxuz5dh9l+cIVT8TdPd6lqtlAlyzZ7eaKiUX8tZFf9xkvUgTasG4vVXUUwsAs1Bukr
Vt+Jtxbjl1xUvUjaRagtxhSCAzJ1y4BcrqfbH9LDCSjOuMxU2mPbmR2H3Pc/+2Y5/+79sPrs6FEu
h8GfBi+Jej9/5yG6JU7gySECrbodRZpXnTcC0aIQmBLwRxZRjsj6eBaGfXJ7qcTRqWkixZPouzeL
tE3JTafmT5ltU/zSLnFzXAel87MwC5Ef1q5d+6OUa0hph+7LN2fTZZ6GlMrwsEQZ61Nv5NmYqML3
vlDf64ZDaYiujuFlbr8N+rw7jW0Jt3izjPULbsS6SyJhqLvOJalO5lZaiE0gVilTnz0TxZbR6Hdw
3MqvACzAgE39MC1xFJnDdyGyFkcZXZv/IKI/fKnAWiBh0Nvye+WtfnsQaJ35cTQPiOEFBWMlZVHs
HAvYZl5cZkXzey6AEKWd55fqME1LECRtaFYPNnSARwtWwpIMS54POFHlzmeY3NQgzWIMm0/ZYPoD
iLRJ/7PtABOOo2V0h01o/OTsAPs111KDmWJ/NXRJGOTL5waWDqEpPp4eFjga316J4CB6KEi7W/HW
2agJUrRF+NTX2xYcQmMOwOAEBvAFcKooS7pus55rM/OyU183O+MvcAsmxV6o+CeelLaRII1nqUM5
G/ZnygN1iwLmDEBvrGvnV6+i6A3sI+iGwQrHJW5VPWoM/6r10Vmm5rUn8z6IXdEBbuKJlA+r3a2f
3Fpun+qqZa8KnDZ+hxlx3KHeCKe5O6R9v5QSIcyqE2F7dBe8vOKoGYcVWCUaibFRKrd67bSTey7E
mP8jaq4FLOPyXCZrObWfetfJ5bGcILlMlPnre6R4tpb2j9ufl6a3/sGRrcQzoOFPGJHALrjmR1Mc
dBfMv5tpc9AZhthDNVn1XINmX0dvIDlkIl3HNThZtu7bxMk8XycIIQ7/ejqrvHhrzDw/lusQKE6Z
iH5D4u7w1eQ2MeKt5rVMsBDfchwuC/wR6UGr32PhTxuxRV5Ti64rd40tYAVDYolOVLE16+ghFzmi
KebqLcla4fgTu05bfp2qMf+3bux5SrNAhStVbcN/FI5Zc/49w9V0nCqPAAOpRwBKPKyyZZ1jd9T9
wxbaY5+shMzvMwM63LHn7j+P/pJF6aIyguOGl8imVriOIXDqAjlQqHq8ur6fdV9st7Y3QDhCfuzW
DVd6XQOAjbHYCR8a9AamNFgy9mRtD0t/J2Gr/etoQ7+ThsZlxFOumhMRho1M5jKalnSV+61FF2N9
XERd+HelXRZvkKpCa6/Hwww8h9dN7ySy+utprSH5H7klzHchNtkLQYG1HupRNdFbUvjyEc1/ct/O
bQOVam8F6rYaO1yC92blRt5E1RzMArW+uBEmzw42VnmAIE5lFq8NQzR1PHR11SQzZAvex2lpOKLc
9v/qbSjfbf1K9m+5OUaaWDVs9t026OVXZI3i1Pvaizgvw/Kx9tf6Vb46w0fTVDyD6JDTf9Bt32Zx
bXPDJojsK8RXXZPH35ASmZQwAHfgd7P/rQpLTpi5dc59Vqpw4AsofcZZx6WcWNXcYCpm5FMdC7v2
35DLFUscoOrZpG7pjOZhk7VtJ0veci92zuJ5KSAdYEQV6gw2RyQKHwABYVcQZHkmY2NeM832y43X
PaIUKm7afuI/FlP0UFf07XhnAqxWszma59M00DOkf1YReJVIqf/b2N5YwMwniAVOqXBvrHqbvZKt
o/yFKeiSoR+bWx+UasQnwxujr0Fv8siLijt9LPG+Oc15nnXHDutApIl82+qoUDdGjbXH4htseG3Q
QvF1/XWKzKmhcifHO8wwc31XLYXzUXVj5ZB/WIUTN50NpjEaO0sfzdZwAXR7YDRSuhoDb8Wsswc3
3H1mc5dOMVgkD/0/MqwKB8PVzudjTqtmQIPMQFB5gV42xgiEyh+jrbfuTru58V4pE5GiHqD6J2sH
iCReh4BaXPrAx2PQEfadVsZC/w5ZTPyYlnn8EBVNayYSn/PvvWmJ1zkGGyuu9k7V3pEnW2UCpYKX
xCDZkYSHyn3buZmmNxjm1v28GtZ8UsDu+rgK5/EjMikev9r0KtyPVt/8LpuyvJ/9bJaJDlBwTIa2
Wb60gPaGOLd6f8Yd1VmWJB+7aYiRgckabJhnmR+skUA8iTSZTcpWtXRCK6n7mUt3Qq0oKoIy5pUx
zDeWARDkFclBUMU2smmkUpOt3rdFUfcx0j/2T2jnHiFIpFHwDdpGHeZSs8lc3CvmGMGP9p0A0ljH
KA9kP5zRGj5vjeqWdCH40MzTngl0alFdOq1yoHAeLrKLM5qWoG/atvjQl1v0AGGB93/z124+9oRJ
bly2kfg5tE72D21PSyVe2JpT4mduw7Boq76t6SP96lyPCDs3/fcKwcAu1kYn34rGpAG7am/5B5cV
5LIjCx504tZNP6crkdcPPN67L7vCmHGciUe+Gps1/ka1T0k4pGO4X9JqHWJJ9PKPqiY+z+7Xieoy
PIC3Gf2Y+WgbVfGTFG35XTVV3tMQqNiirmo6STYxtXNc5i6XcLZ4/OB5thBtqcgxVE+JKXOGNyAa
PDeRuql+4qjT/XRFxKtRuQi8xW3eb0U6lIb71R3JzRJ3CeavJLRcZFxY4CRDrufXUii3SFarmPKU
MK/Z50chKTJs1frdW/y2ifE0Ibf07M35DlGUyMcopmFJpRdVHfylqf5aZMX8yxsVUI5SkTrFgFOM
ByJ2j/R1bKvsNLXKmuNxHBaWufLa4oD7dg95AZzlwKu4rN9UgQhdPASdaSQ88OV9hkMEt00n1x/G
LIpXtb305aO2gALVhvI/5xDF5bGZ1wgyQt1EzitUoYsmDXslTmHWDTIl7mwAsFjr1JzUhDxDvHSr
I4izs1oDO7FHMmfl2hxrtVSJmfl7wVgJnnHsKrp/cRL9P47OYzlSZAvDT0QE3myBMirZlm9tiO7W
iMQmkAkJPP396m5mMaanVILMc34bN6nZ9oodEOyvPVwv7a/d8ledhkiDmpwzunhYR6/6CUPt13mg
rPZ5ce2qz68P9a2kYILBfQztMcNX4JJzX0cAbUqjnjNMjy/xFs5TpoxZ7QxJiMX1ZzXzd1PseNIS
a6exnCV3Pfd1Mjopo9X0VsZbvGZRTQJFak2T9afl0vhbrKH8arxyT1LTJjNnfyADNuKQqcvxVyfm
+BusJKvbQX1sbRTQFG6tU3Tk3t9ealtWf5DJjL/IX+q+pnB3otO6OKPOEhKyy1SF28CN0fWzzMTe
RRz/HXLgtGPDYTluhP9nnif94FX8f9OKmoTvdWi6lq17NwU5ArXHVcNdHWT2uJqnln/23FZWYp3C
ztl+F12XPBeLrpO8sBBe8SaMEzezD4Cf/t8ilApkDTdLXewis9rZQw4W74GbG9NXbw2z7ynp4uTL
7KHPOZ70dcB5R3Z3OgxF8h+ZP2OTMgxO0yGZCr89kosQ15kXCw7UrTDdB1Ojc2cIlZ5TfwgcKqoj
R6mjtMf4z1rU25dvXH0JnGtGHX2W2zfHNc9KrAP+h0k395ySKAbL1AEC+NZbED/O0T7umRfW1V/m
o8RPt9jqL5gydARKMaM4AA8Yixsx7OBIarR3c6oTUwPZ2zW3R7hPUcJC63Wnms18PU8UL1mY4gPL
OQjVqnt0K9uWVTquJBfTCATVWyW//XqcpzZVbt9ynXmbiW+twdhvs5jmRyzfDEO734k7hmbWtU20
ZY9KQi209C4ugF21Wx5zIUq/NhUDoeSHLnDLXzZlCufedeWz2ZUiFD6hiyMtnHiVuSlENKR7vJie
gIg4rjIhNt6OGUsFcNnibofYF+3ffXGSL9vSU00ZWeJAyI57MqdLvLllOsSA5Nk8D96rZy/yq9bJ
SvPjFBsD+KwG+4a9cTZMrGaqMiq/bCcTAMtlGsTErpb+wL4RLqN4sKmPH6/5y8I6YkyE7cAHGTzX
InT6vHUpA+axGqmZ8p2QwJM6WuV32C50l5VLtHPXJ7F6b+q1eDarVxQ5JIP7n+KneWgSFz9h5LTx
r7XSK5+xq69uZDf6KpBkdWlTs5SlqgDUTv0pKf9o4hzLrJPjwA1Ting8DGzt/7meiUVOtrLkWtGL
t6fB4GELlQiLHwqv404dAWjU0bk67C56H5dHq607gR5QJ09DOM0c0Ja9A2xEk6dzC7S1P+yBtHgY
YLyd1O529yJnGfp84CL8JMsFN1vcLt0vy3fEPZ0Jawiit8qPaJuVn9lhtb6a2i35vsotvFiTtKIL
8uPYgViay5WQ2zIKL5Q7rz8D2Wxk4aOf+xn8DVim9G0yfjvkKMwrup2/+yVuWN+KTt0zmW3zqbta
/dKkAuPJ1n5YHyfG2K8+CWdyaiDj3xI6tAQLuaoleZBz/EWZV/u6EDjPVbESk4oOMmYXa3a5PCWJ
rAWbtnSdg9/tXYilKrJfIASt6abX7NZpUrjhQxsU3iXixXXTeCnnr7UMur9McO6P121wAYJyVRq7
Bo8gn6GIGsHEtjvTqegr+xYP6TAhrC7kmsemHP5U3rzFUGhJqQhxSEJ10Hs5vS9gbS7De9kMB2YB
oMVo3iuVik6MP6092goOqOj+LVPJ8dmC2ca5iaXFm7ev3ZNqHPGDQocd2x3n5XV31Pq4+cL85vnw
nkOauf4KUM4mXRXqUKIxi/GrIy/ivixl6Z72Zin/bEyMcTbVGzxgErGMpXvjyo/SLP3vvXHsz6V3
hpeJrKBPq1NTeDLoBx/x60d/qqosBmIRt6bORxC4Pt8tZz2hS0NVyJDp/rejAv+tCDH6bPu1WzOi
jlhcmVTd724D589Jkgp55mZekjn2GoLzbKd5Df2C+LzGLRCV+Nz/dpoQzZykW9cmUxbY67qekgmE
hbFF6neIa/dXHSXyZQ6EvHXGKmrOurNtkTdkg/iZ4TJZUy08m2oIl/K4dDN++VpY41bCw7n1h0mE
xbG5Gts7SDkF//VWtAGnQvl87tVM4qZoq8EH2m7s4QDnYy5DaNYI1UOk353SFSOHWulFp54I6Tjl
uUTyzE9H1MA223ccRBxvVSELmNfBWX6QEnKq2JugVA9ySVpHvq8r28dj/roN0cq+oNlybrxhNUG6
SXjEdEiaNU4ZPZavEddAn2J7icHiambZtIUV6NNxqHzaHjQnTNohwK6gTGYeLK902/8UAAN4tmMj
xpyU1x99tIVO5muaqPNNTNhxsYlwNI5Wy0q8D6SqpAFA4ZZL0NMSKUnbPs3NSI+vMF0ouXNlkmRl
PU4X4xLvxkeslzrvaHW+pw8kCTMabOz3Yp3CHwV98dKXCzOGbng+Z5S+EzhhIH2OJ2UllJi1/Yer
DQG5axVVb8vsLd4b7Rb+84iUbOiP8QDp/QFnrf6bR9fijFfxTF3kSXHXBSdC0of7xk1m9pmxm+6c
Cj3HmQC+pTtsiyy+Zs6OGybDtTvWAxqKrA21/Parot4PsmjjifzWEOiZ/q+E1Vku89uojABl5cwW
pyXS832iNV5wqrGXHzGa68bGgvgr2JrhaaucqCfpYPIMw3/d3ZvBcZ+aZbWrw4hBq0pjqbafugu9
Wymi7TUYnOaj4ykNSDoezdO2etMfWY/hew/RDoJWhaybvVfPby1ya3kXUSYysRG1hrVydBmel86p
gYSWJWCX4CCtxocBdHVyzq2MvaUBhAm2wAPatzepqWqn9agLAQsmVR5gBfqIKafemNxthMHNQUxO
wc7leNVloBSNv93TLZVa8erY+cT5+lZbjfcUg5wybiDF+c8QAvQxN8r6nPgsTtrbSbHBCykHeyLb
+nekPR96hRXZy1Ac1BcNpjXkQg1XHJBT5oFg2VbiwnLNeKgLPg6sxhpesEb0/tEWGIS+Wwe3Mi3o
06xJnSsWJpmEgZJELjZ6DgdkaJoMtyKsiodg9e01W7YueenNuI5nl6je7bR0pLxewQV7OLuGJe4Q
uN26HFqvLz96C50s8MUEpEO3nAgzm9jXOheb2PWtHZZ1cVi9PUryvg9jnVZqiEwukWLEjCW6f8ax
sdUQ89uIFDsyfBFNMpkXgAipsjpp7fhb2G0AKxiLyb6o2dmDNOL2FJkaPMYzHRdtw8vEmH6CGNrP
rppZHMZwGLt87LpxAz/FunHwnN5mAaxKmzSuZEPgcaRDc3WeqAhZkG5yx324WxED/vfBNdVx8L3O
PtB8sb4v0ayT3HiRxsEcQmWl1JOY/ZFf3+hmOoRxy/USD7dc2t3nMhnvnNTt+K/hBhPnBWVuc4zN
1tXHcByTx25RXZPzsgAh1G40CtaMsEkO0sEtmlZzwIBYAbAPx+v16NyUppLRfc2i8K9ofRq9xsX7
LbXYZF63Tt+nK+ksMktavCqkzu3OT9D7TDYpcJgOT040uPppC6p5/wT0WNX9DgQeHnzGGJEWrSn/
w8VXbicH6q677eiBYSWYRdS9SzJI3aMzEoWRAwr64w3S4ro8LtEk5IO/DcWalmaP+hsDnD6xifrU
J/NeMASDRlfbpfN85XxybLHRJAMuhCqtzDSHaVtxBz+sdlsFT1ZC8ImXWsm26gPm0faVqaoIb1xg
/PIxHBcWuyYONjfvbLl/ywoo8M98NW+eNA+a5pW3Ie5EZTsHjyOvPlQlfr9s0fRIc+r2nXMc43Jm
N+X5gUp1DCFuFdHBmn9TFv6FNKpQ3ybXofuNMoV4/Ve31qx4gzl80ob1ke9LVWp9IHt15miTdj2R
1dt63n20rmF1Ydvtmgx7RM0kZowgObTgxg//yTAYkhNQfldmbazgR0RQJssBbiJ5F1tioQUcd/ef
t/lqfW6LUM0HaZomgVXttbo3/kJugUj80T61wnWdewJmLedk1RWknkXFhDxyzo0/q2dNNmW5BbEN
Gi702O6O+R7KGhykKbbVMLwkzs/CH77cAcGNzdEDxNRv5Iz1bdrQR7veiaBevGzAnMBwSwKPl/FD
j8sn8TzznUO13PTNRRKbDKapd56sYoy9TMRDYj35DGwD4Qz7vDwkhYmhJHnfzS9HzpO5B5uO/E+H
AJDooGhih1mRm2su9RYbfc8z7+iMrXIgl1PzAuS+xBWfLosK7H8OvPaUxxVQ/I1n2na4AcYlTQC9
PZeGxn+gOKe4HM5ToAeRB2Fl1MmdkQ+lOFU297UFDlJp1xgbMMcGOs/GTa79fR8pzv6WvVXlZuoR
pK9k1XRpS/JzmyKMsG9tZ6kBmSpv2jJ38BPNKkQg6iUBaPvehw1OGS260gcW1cI7lmNB8l/J+bDc
9cnIcwOlva+5ZtSRL/XVLMHdVBGDs87rbOWSXt2GjzkXdXJAAxCuWSH18uU2++JnCUboPeUB0+G5
bKNaH1Wzh2wNCaXdB7dfep1NPgWeuaKmbTsUJMq5udD+uH00cefakJP+HL4GanCiSwKXylJIjmHm
WT0fnPov/TaNa4Gjha5emS2YStdMUXC751W7LDSA6k3r9XLN8d7ydfer+oCLxuXHCnf8M8KajHxI
TB8884dzIUp+uHeljXLyXc8JcRbw+N9sToqqerfczhMv+3tYkQ+eUq8c23e2WG1zHBLDJBEY5ksY
OouxToRlN1zqUnMPNsLawxzFxw7brSNv2DJg09G7UOTiv/iss6jtak2gXQo42fSsCcW8v8vNpmCN
9rm4gE7oYXplMhfF0V5sf3iDeFD8Ypa6K28BLmD9VaU1mDJ8VnhoV4HwEJ2ZgrouW2d5B3YX5XFf
C9JFcUaEYz7EGIUvIoj1+tDPkXUfIKeIb4APwiG1BrtybgOwjjduo2LJNbgC5zsY0ovLtwAS5zc+
LTERQsOs3TyS8JXbDQByTleIo47KsEvriuXxMuwBEcA0oznPALFsFO6W4G1RoYUlkt9E/SV8R+65
NHtVZF24D7SDj9Kv8rpHrvN76DoGXQ82qk4jr+3b8yQrZT8mDZbJY7d0sX1vE2/Hgb2AEEBhQosw
5OAE8IID2ao1KZWQXe0hXntMZPOkcPKIugXTdRD6Wg9egdr8V3AN4PhotBAC7neBnD0MdcGa6yO0
Dl6GsLKXfF7IE/6udRGPcAMcmy3jOHANWKzNcz7a7FwnfwKhfNhdp65yC52rd9CBSfS5L301HxPk
gOJlntaJ6QETXH9cLYLDh3bZ5NnQSPvaET99O1HzO+VupXdIRGQduSecoL+LvFoON1xqHcLCtQIR
qbSCF5wqb6HB26u6T+CtIsyqMS4ELTDB/NPtOqzIA2hn/2YoJzKYFpwf38PgqEcD1/WJlX39P0xi
g/trvXlHkGHLvalAgMRrXCbxRn2VH425O9RWQXQQE/BK5jEcF2IC79j3JAW+ElWDQj2ij+2/elbr
fuk5A83BMlWM6IMTj9j7AZbG8La5z8gtpLSzrgHt/k+2pq1PGEybLpugraPc7aNwOY4+rDwustWa
R5lGe91QgWzbyzLcl6SIL6QTg8jcIXGtlmNYy/GLJ5WJjkCOFbMHGZ40izslZdTK3XHit8s+fbA2
dMvjFCTiDvvwVJ7EtC3eUYIGAwcsDQStSnanR0/Te0U+uE1D77LRMTKecAL9U6PtR2mA/axLV8sz
9xXkfHKqDKdI5ii4wSzoVnc7u+PE2jZbqpqPfTMOJ42qqsy81tvFnQs71uXFjDX4HJOEhdx265st
p2h2HjLpbs6e6zKQcwaZwNXMfV55ENj+tXw9iMr7lV4hEtN7EwPhJY140Gg1kQyJOeAHq5z9EFaO
9k5b0k+/634qHxbsyYheKj63Q/Jvd9xZmN6FGMOHjc/dZ0lBpTzgZSU/zNq6f0g7aJ79oB2+ysLp
kFgsu78/XSU28b3jLaCriJQUaTWg20MGCiX31BAV++U1btQcp5aGt9ZGWXjaV6v/z6l4l4/tWuj+
SP1bEJx4/3R8cEW0tEeyIZBBabltw8m1wmY9hWgGVKaqMgqOWH5U8brMrMP55PvXK6DX9gd/mDPd
aUZS5w9Vm0lwktJy3FwKs4vjEIcqOW41dSXPc7FUb37t87ZWcip+N3GiwChW3/uC0EGpVRMM9qI3
IMHDWprgayoxiaQjKxxsMGMJbzln0bsCVRNZIabxx9B22uUV7M8DmF+DcCbU0RPm/wn5Qhws9RH+
fOXlcUVhp7YnKxRFcrZ74gDLEOy7s/s3Idfkrd7C4QddsN/e+5tdIU/u8Da4i2y7LJICFC2wqwHX
2sgne9HBKMUZcRaVbusCNv06R1dagll6/hWacfvroLbpiJOM2UpjS47fUHB1dUcXHFd8EYbKv/U2
rdSnQREZHYvGVf5pEhwpl62XY3XCkkcn66i8BVWMazpMpgWrSw1otN7MVaRfCN/l2bSscPjqcKv9
NWirf1kJWc1ZXxIjAy5MiS59oQQC5GFkBvPmlf2Cgsqbq+0sNmuRJ2sZ1+dlNXA+wPnEvmg4+CR3
4w12qLRaDSAnKtoAhoEFFrmG2dQZqdJscv5T+wkTEXiYxKxIcigbrTh2LHz/ySVeoZ+2CLp5RPAw
3u6uq2UW0vD13M16/y6KZR1vkPbxRTA+DKmiCKQ7xs3W1yoFINu691lqw209L1xANG/CWKf4PiTZ
x4OrxGEGYK3vG1lX78I0bZOPMnHsQx+NsfxsW098YjnoUa9NYVKjEuxmJ9sKp+AspydUn21H+4YY
oc7+qwuDSgflfbCjnzLLX6WtneiEsZr1GVkQ/QhRENAnHRuqd/LIbYJHOxKT+W7HGUBl9uDiMmMr
7MJtbwmJnGsKq6Pwa4JkEwL2iOLzhuHduMRaHycz0SHKudR4B/7aQpKwr/Vcyg6Ptho7bTCfVvun
I+qiPxHnS9AZGj1fX6vD2bVdZPVvdVva0f0YFqXGdL954tC2nVkhba3wslnzADIkorGFsJmu4ykJ
mEEWRAHqkBKXOUhqaRfIj2Bb+pu+pf8lX/q4BETV7iTy0XHDjtghde0PHWKgQEdG1vvWd6xNfF2/
bSvmH80DnjFofLjefF0EnBDCShvFA6c0VYflurv5PrfRdK5g0v/sqgIriwCKF4a4smHMqMT4uixV
stysYnX+C5UIi8ME2P2r3hWKIi5KgY1iiMIrF9nNBzzYIf6RVfg55GHwOqKdCQ/4F4r/CB5EiHNN
zHnaQ7erT3NVhNGNoHUSwa+nPJdrYhhZf4PdRjDE8i6OJTNjfAr4xf/YfF8jw62OqlOLKrn9oyZi
8VMGDgjotIp69wwHUF6wwVvzDQ7SpLmKXvYhC7uVZd4FbxyfZQh0nrp9DKKn6thZbzlCa5MFyRAf
4qtRLNXQB845IKW1O7EVCax9ZSPaCzLlZkWBGShc6BGw2pFHvm/uHdSkHS8jkMYBd35x6adtuhea
X/9xD2f7BaZseU5iL/makFtMV85PSBsw2ubhQZVo/1RTYjWphsUUOayP4x2bZIXJAHJvkX+toN7z
WE3PkfFtk1ORs+LfnPshTjUqOYNKWRn3AMTewPA5lYtYHEC+um0oMJnwxjm6hLUHxPqMek9ad5U3
zFWejHC+mW83ZNO5wrX2Xwg0gNn0WCRhblo7uG8RfInnTfKJa5p8OzVnSFCq+1avTv/o7WaC0VOb
SE6eVVXX2HzlPNuYLknisyp3/TUmssQpbA/6v1Xq2tyuAL7ykYFkuwYYxAXTcG9L+wTPykjih3p0
n4ChpKY5NkSCM6q4/pDKNH7qFW4wve6AvQxTTQkQXDBNWB/OOFrL3dY6UHE7TpLgAayrXY5UBwT+
myXb3cvRcK3gxGHlxdcVxWDUQKEkcsVYW6WNqbXF1zQkTzXbGVg1LKh9Rr2c/PaQetdHPfs8N0nS
rugWPW/7Ny/JxnXYjPDMJbIZHqpClz/WMCXLc+lZEHO4jDrvyRfxhmQUZMg87d68fKGebSb0q8j0
0nHZw+7ka5RPdI4nliLCeVMqk2u0PO0z3b2MsYX8rRmGSswm0vpNdSujYhu4WJgSr1vMa4zpQ/8L
QYDRjftG44SR+7C+7LSE2E8adAh9hDv7/niuzMJdVSJ/++VGm+8DegTJR++09p8xmaJ3D1n+fF3y
xt9d2dbJi1vUKMXdvauTO2MPZfu07t4VnoqreDy5aGwR9HoIh7PBhdn9tVfASHfTNI7JnTNEkAm+
XpqXAFNp+GDp2a1PTEGFe3AbWBNqiZLFAtSyiom1Niyr9a4OAJ8OZg6Xfwm37pIpMQwc1UraPVWY
I3t+4TgKoJ+wt8caAWKXhtUwo7XoWYOfNtAimRPs1RcpQ0enj/6wt0uKBnYiCpP+OYD69RpdwNa1
MMAMO82vk47R6Wl/L3QWTZsE95Lu7GUl3zs5VfNoJINGGA+ZzYF7HWMxCeZyg+gGxUcweSl4BZNs
qwAss2bsYskoM4x9RuYxnzBOBnv62dfac8VVDD1vhylxAzdzwMB/V41p6ZZ3uLQPcyQi/15Nkt+j
r0hqvifEAr30kLiDem0BZPfjRiHJ9WlMQOCwYdRttoeqb48+upQN3SW7TU1sBwIoD9yAcz8MPp0B
VClj2nW6U2OpYbo1S1O9OtPQqWxR9Wbl84okF/rVQ6DsA1Y/7tRtWEfqnjvv0A9lOVyMM9bi1o+H
haHVWxBk8tUwivaV2R56EhLI8xpbSZTqWsualVP1ivE72S6YP+r2E3tzdCYedH4ePYFWaB2H4Y8J
ovYH4jF+pYoG/Ht2C7T2u7vfu3bQPLbYnJ9ML/V0WKElkHPOm/vcMhNDcMNtP/sLlxAEJnlHjElm
0lnRumid7VktR9MrL7kDk3SifI6F+uJtGNe8Y/+HB3cMFQ6SgfR3Fy8LzohtQvu2lUH8U66JWx7q
SjVrhgpODedEjN5PZ6FlPYQtCgrWSAr2yMkd6yGEfG7WvzN6/49VcUdcCexQHf19bOxHZ+Ocz+As
3OnGq+ZiPzXo038jicLx4G5d/OrQ/To9DijyNHhV5BhAlriQj3O8cUireCGzblnj4I+omjo6gXNA
jclSVRcv2hIcDMTVt2cudY3ONCrtAyWCU3dAwIpSTmG4vN2HHTqiJjBSXDoncX5JreS56CXqJXcs
+KG2yhQMMtL2L3HUccp6k1S/l85y7WMkas53tnYOWT4ki1JTteH4x+FCeVtFqKZMkIXjHexAeDEF
8Mz6B6xP/sCU0wcEQRWljDC5DMjI6tB0/9Y2nj+2zRrnixXZ5qbR5eI/D04wbH5adLP7XUYRVJrf
u+D+huCw38vuAvmNBDVbx53jK0dTXvcYcYcxOe5zwCYGXLuK7uhYq1PhWjDzk7Cs/puQD3bizban
L1m1tTyizkKiXC8LaL6kBTtgYO/tD9rSlHjFemPeWFmw0a3xluTbzu2JUMKzMdRM3MYbs/tf2g3N
mlty5jijKBhFlu3FKJ47ls2HGpnlGzkCMGz+KMZ/EfI0ncZNMtxGnqRNOC5mAB21N9Ut8AdPESG3
q8pi4QZfFCjX71sVV1Gq4EhEOm0oO7BbV/uS+q2okF5d+cK7mLqZ9eAUCjlGpB3E4fisUW8Yz3JB
UdRG4JcmPOPV37sSqgJpxL9oxuB8Ey1mxzpt7+F0jFy04Vlhr9548hjWiiuVn1TZAndxGC3BDEZo
vfxX8TqKi+5xqoEnum6bW8bjmJ0t6QNZ8QPVd10Hi4F4f0ROgogQzXzvsiccWhVb6jAk5fpAWJIJ
/+58k0SrMDfat0Pkdxij6tldjqJKZu8QGm9rzm20+iPfV8BJ0e6txuSziLXK2XOIrE9XxkkeBxv6
A1x+kF/EbeHz4lfhVTl06FVjNNjJX3tAbJUiFm+rh91W7Xiwwhg5F3OJ7/Pl+j0ndD8uxXyc8Meo
c2yBs8Pe7ghlJ+3wzCnkriqnREQmiGw2VL20lIOEJSXNYQdCvF3ULEI/NKxz91GkVZlHQpfRXeht
zl9vJa4YMnUx/glwad1OqkrM8KdRkXKzakEWf7kKxIacJgzQEGC+eMlDq8TYxYARx2flmLq+30dH
/mNb3p451ZrqhHmmurdUOA8ns5ZVcIsuPHklkar61+t5I9cMYbOPErifaPySfSXY8EntTrto4YJG
SNVXh1WgNM3wF+BAgrEtAZoke+ORkDQa/MbK44JGexfsJ1Mv2n/CS+VUx8LV9R3Jy7s+KAbe5kGx
Zxz72SNqK7HGiTOT1sMfenv8+oLWcPlM/KJ68Nk32J7LRv9Xhnb0OXg4rR7ixEzyvE+2/hW1q9f8
toEk9re9XEx3jvVWap5RjCM5K+SSMCg0kbqpy4gbhiPQeVsdgm6z1m856xj5OXy5B2eiRNmdFAG0
Tu+fLDP7Vo49oX8Gw65+pLVY/waUe2x3MwQiasG5+2N1PXMidYC0xEMThdUhEG3DEFWv4kCZ6pXl
ir0KTRIz7d0ExNDno40yFzu71/iHxomsAOB+j/72q4CvcxbMQcwwY7Pna4+x9NBGFRLCheQ17xxa
iEZO9by7v6MZEVXuoMVuT3YYFX9Dw0ed5mIm5AgK7hGjCOqqeUUJcw3AQb6ju37TNwHw97EJt3VE
5MCz1OGB66cPUS+We0a5SOjg5AVmPY3gnyOHQhf/wTbs/UJR4f7lbF/Cq3yqKY8AjqN4cYQ9D8j5
uan1L9EYCYmDsLQ41N26GS6hoGrOjlu6TNvhxoqJsr2XuQVC/ilH4c8nb2PhgsYqZXcvXHpTsPMV
cn6yRTCofBm35a5Zmh6JKXpIFigP8u8er4W0UcJWO3x/5w2USfq6mtez5QBxp6Csztkd2tBG2rVi
6MGnoeqcDKD+Nqj70X+kZkJMx9C64jJqSaonPlD/hbSY7yfdocaY2jZHACxQrjy8eMUK7zHvi0bZ
S4o9RhgjN3WpI5l0h8RGlNZgsUN+Tz55fOKMs5ezJdCsoodIFKcjgPkrmvSNKToY3fK+nOZeP5hk
32dAjWhHsGDjgIC90Nhc1Iy7/tRNRRE986F6MFzcOkVmCtt7KyRcbjY4FUtvJERSoL/rOYwTgUpw
s2ec5guKgbvCtYLo2ONzuG0aHvpfkU1Y0pltHU0+mxa6uXB0rOKzbdYZZLSX5idAe7DfsHxN68mC
2fUuKOQZN8O+8Y6o21sepLpq7mfpGASpyOJfMUwh+OI5le0zI2jyD5Vjg1U4Kucxw8XlsreSCSpe
w1GUf5AWRdtxIL0zYJ+gjg+Tlh+5x7H7//JJOJ7Hewfu/s81w2RSJLT1PdDRVF0od+iWbO0a9bO6
AqS7icAxOd+vMghr7PltV4zv+9EO5mG/SF7lMm/9qnqqyq7GlBHxKr9zO/fI/xEDlPcCgXR8QUte
efnc4EBFHwlzmxebHm+71quLDEgv/hjJmWpO2AWZZ+auqYebaHIacXHcSlKoyYiBJweWicBM2s6r
tCygurOp9dXwYWTDW+a6NTmWJKTRfBD0ttYHcO+4fUSbS8B+uG4YUjZ3KB9pi5Pcuku7HiAC/OLQ
1Qawe7C8+I0qdYkIZdxMcc9LhqriutK92KXvzOd2j5lciijmiAgDvEkh/t44V47i6k+8QYZ38xr9
j7Qz25ETCdv0Df1IQAQBnOZO7S6Xy8sJ8tJm33eufh480oyLSmXKM+qDbslqRwIR8W3vAtPAphnA
5WsM9v2QqPlLVFtA5Bra8+42Ez6DNzfRqWzMuJ+eMtbhrUBOiDjAJfUILek82uogBqy9wGxj2GcC
KuA+N6Smc8PS7tt0NeCqrQpMmRxB4CTOwYycTB5HjXkpMlx5fdSdCERt1UwiOknlR/LQR6FYIGNW
/Ni2g18Aa0tU+ThndZR/4PwWyvMNbRg9uBP0j1PZPYY25NltUYY9GFFeIhk5ilWmXhrdPaJAo3Pj
lnX+EExw2D13QmgExEsyU0lEkwPgxY9/z5Bba48JJ0UUjSk30p8yzXLKDapqiWS3xXO6y9rQKnY1
k9QfTcb0fm83WlFvK5tOEinWHHxooAKM36tW4HURkbElex88iDqWPROvU9nXNpkjjgi/BSESWoeN
JdNOV2acH/tO9sNTaxSJgs+XTq/2gHQ/S6jMgaMg6lunGAP9qLdAXTfdHDCoQOWBiz0PoCjSjaqI
PFkC+mUzJsrgh/oxExBadCkIZV1Tv9zQDuptYI5htHXqqTL2GSrW3uhyfW4BWKJsapEt18SvsW4+
NX0wK2ZVGCoVJE0SVlbQTZ+axHc+BAx7DFIHUPw7XbbYeBtgkYA4FyFM5xzFZogcqdUMG8u3q+8M
RZjcu7krqGRlCLqQlxPRuSAvTE7gx41kbwp7pmGjOhkxCYNHvEcxJ7APRs00wJtAz9C6ykGckoIl
ekNLEETdrrKHSNvGSUNs8xF7lN44gyE/WWPm/GIIAf+KplAc7MVYjWI/F9n0iVPMSBH+5bRxjKkw
jiJHfhYNhV6+VEAOi7vCHab2Jqis/pUDvpjy9V2wz9yi+CVaMf0GoRtBGqu0CRiYQ/JML9yEXw3H
9ECYzaK97hYtQ294dO5RG5u53o6B78/7WgiqKLb7UwEs6jdzdHcH7G+hH9Gfrr/MUz/H/DhFLjxQ
bsAm6YPqkXFVRXo4AnPxyNwHh7y8rp1N4c/cesJF1WEL2yYv9vh2WEBeloJnN4YowW9IaqfPvWu1
H0VlNF/HzJ5OKcpE0U1Ft/rWRhxt4a0O8G1SvFOA7tpI/tPZ8uO7CtjbFzOsnZzUsjBKkNdc3Gx5
uxr3yFj59DVxWLFPzqA5yY6+NWwgd0BsI3TAOxxLsH2oOGiVAyjBCfInvMGqryjchs/RlGhfjS5n
0pPZRJM75LBSsadd2VtbsO7OnR2PcEcw2ZFgn3R8/ERig5HIfHM4LYNQhnzg7OmuA6q7b+RY/tBx
PB723SjRHkBDAZq47RSBOo5Ydrj0BUEZPbeTcinwiD0biiX3tQF+F0GV8TuFspBvvVgAmOMjvYTx
xc7m6rOSCU5TwijC7y233rhPM93+UWmAvDbgioPxiBC9/p0tgVgoZYpOXWQP4yOaEnIRyZstiXVI
nST7xu2a5glrlxoctZiNn6qac6oRBnP5rrAR0N4Fs11+jBD8Efuq7IKnCNWoXwRzW+20Lp1MymnU
H1EETtMfOaM7JgRZZVPXzIMEWCcSZlx1X4AgmgXJ/FxCUwUO6yTWyTYpzrYhUHtaSCayy0x2kaTY
mkbIXEOOgYssRYSCUQvmqzsmQdH7hPlBfcF8fYDSIjLrMbADaiEjdsWX3rdNIACFPX6IozRIbxXY
ld/K7qMvjVZyljPO1p9G6dztELnL7C1qSOGrXRRxf6qiGYqGHdjuSXOFOTxACcPaq3fHDgilGYnp
xlEATUkee3oiRYJt6SZpR/V1GkagAmPntv4x6ahgDHh60aHEMEUnNWqW5jEcSHmctXm666p26DwT
1p27UwlFKyTDwbVvGZs2GYew4ldoXUE7GmpmnDAURUZiZxltXD7kgY+qBbtX/5RwW+RHUFrYO2ki
mZrnRHXxU9JM808DgoM3GhApGdN1eNC3fVEFGMVP1gwfyaFt7frKNbeyJAvwclVJHTSKhsycjMIk
OFrIMTCYt2QR7EZJfnmkLx8a38ZmHF4K2WvNAR6jup/bIKuPChWIr1FHZUGTtcyewXDmw2aweHFs
A8QJtkRMBDYGX83PRdpZ04ZGwgRgt9aQXgsMBaCl0yZKHqr9KTgFdCr3pj5GbN8oMySJS1/9ak2H
IqEFXtBu2kGNkmpn9j9kXSa0g4Az8FNnLqc8OZjiv24urYzWitKf/DnJQNkXTvdlcY1ugIjVJamC
zF3rZgZbibs7QiGPOXJVEm5/wNZadFAeKxfU/n4qe2s+QDXPwcnCpdlY6I9+H6DP00V3rOa7q7JQ
8zr6bR8r2AnxBkJ09NCCIY53hijlk0FvnA03CYYD5lRE/j3swwiWZ1K7j42RpuMRViYWvOYyogFQ
U33UjJZOlZ6bbri32rTiJGl12z26QzAG+2lIMRJr0H0vTtxUJF9uZmDny85MMQ4anSRla9koiUQ5
UJIwYFzGpdQ64lia0gLO86dZlC28UNocRKztBLv71irGns2XgWkihwoZzaDg0gEMNBhi/Ujq0H2M
iXRowxBTvinIXfVNFPqBuddGm1YEvYlB7G0URqIdxFv72fRnA8C7KMMMs4rafmrDigu/6cj3tKyC
G4sgTslVjkqiy5jATQOxmxO/pOFmlvZBZ1AF4ikPhbXtGMbQkNT14pl8jZxuKHQDolvDjXWcLTE9
pgbX6aafmKsNVhwt2XRNA3ruVUyTrIjCbTSCAt70PlZKt6LU02Yho5BV/qC8sW30QCzzkfdMWLEs
Hb8whsvTB4ka12e/qBqkF0IBCn+OuEwOaHa19Y1OMfMcDHYCCd8qIxBD0Kn6TREDRr+nA0FPLCga
+eo7if/UBrN/rzO68W9loWZ7i+KGNuxddzCyzTwZarotA4l62tjq2W+8B8uvWtj5rxPQ0dlb9Lh+
Mw2JsDPLgUdsnHbu0QSvQtpkhu9md4hDc/8K2Yc/UDMK7SOSclglTlM6KSohRBE8zS6rRz+sDFry
ihpsb9XM/vgMYQ6LyVK+ONkaEHrY+NDPdk5d1QwlCsfYyTwD7YrVoHViTsbsAshM7O/kbDtA2cA5
47yRpF3+DOOhe5rirv8gsqLhxgbO3oDFD8fPtVxKFdgj/Q1KDKDInCSzh1uuO1//yG6ERqEmkfcA
2CzL2Ac+fRNooKDZNtSoi+y+3g63vjOCnLQ0C61MpnnZVjmBoQebBIOl/ypG7guCDZ7xhi5+/7Uz
HPDflCz1c9iWAPbRwrktAE1Ze39iJodqUwAbzRdB9CuoOmPcARhH+GVRzDA3M3AQ/2DRgmmRCxDu
Z8s3w1eE2ouPyRhxcCKZt6dJFbrOXCaUt9BzAnMTs2kQ/if1ifdWItCUmCLdPRZuLO4Y07Y5Xtz0
vR/zLgWoQ+faemldp282ZSdqDgKYIJ/OQkDwlGSSzcPsR5W7CZCqsraNkS8c7oAUZ68FRvxFNXE1
HyomL90TP3V8rolTyPJrlUszVVmi3c+QDUBXEsYUr8ti5JnJuXlF8IlxUJo65c/G7e16YwTKIWqk
HbwNAB7gSWTdau0mWKwRtrHws+hY62PJ2KCrMe6gMSSaB3N2oxd6/8p6YCOmKIaaqvP3RmUR3pgG
MEsPOrDW9C+tKtjryYAeDP9rX+0RP0a1ILZnhPBgMyLxz7uFcUUniR4swg52vKv7oY0PDYK2IbVW
2D+YZq8vEgJOeD/PQnM+Br6cXrLlMNKpiCl4y8JVL3pNTxM4VZncBrWTCvR13OZLzxR0PGYw7B8y
YgNmajmmsAFzqIIo0Q3fWoSh/0MvQd5JLZMIG9mO72wDCYT6Bh6bjn5zWYwe2kTWTV1juLiB1gJM
YibJYr9S8lvfDHqjnw3wmmRQ4JHobQKytD8qMxXlvq97hc4NsXnbQDHykKHoqyN/FiabZhiZF6Sm
KvWdgFcEakV207fUHmhyz33oBjuTYjj7Rn/W2UPwXbo7AgDCiUpPEyfwhd1NL3paSppTWaQotuV+
Z5xmplDwjXCJD2hDw5ZIB/GCDpv+cWzM9KfGPvnaZGNxH8pgWkgjPjeo5U/5T2j6+sJPNuicuUjY
/RdmGlZ2DGTUuJmIX7cuO326TWWWPmlJnFjbGZRwvLFssAdf0MUI4LrhQgw3DXFmWvgzRSNxhunz
rh3L4XmM47l9LpjfwZpy6/Y1oz0JUhQZ+i9ALgbnCLRMVCCEcm5KLCFta1NV1KCnQS+05huTcj3f
mkNUlXe0OIqbglRrPtbgZMx9qAcahAbgXUj0ZGP4gZTE/GYEPoloPoMjAcHdAoyb9bhqEdPB92FT
MWgq6DCLMj7OszvBJ8tT8uhS6S57LswlGTMX4HjIqOa4BYrGKB/dXCYPUGnq+G4oU2uf2HoGICsJ
RA52OJbB3qKtXJJN9stgtEKD8QMaaBDXLSNycg/YjBJbMFv+d/S3gvip7Kw6PmCEYeb72nQHMJqO
WT1g31xVGyPS+dXQbEzzxnQAg4PZdtJjamRpeEOvtCCFw5wI2HzeTPqX1im1XxTmOW93KOwPk8ok
SMwprtUG0cgu+lgFc3MQwTh1+9QcKf5ns2/Awwq/OIC4i58MdI4QiiqKcn6IqkpgOgvRBvs3wLhB
9vA/wAWV1kbt4CmnD28Q5yzt+96MfHcz29No7P7H9EUtwchm3uz3+GQZWV7mCO7IPN0PaAKPBzDp
esFfNYNSKOJyOpX1lNv7tCNiTR0fDtpEMlzR9jwjI6pIcBDXRNuVcmX587+EcZmGTsx8ys5DLlrH
47AQAEWA85qUnNekoReZzZWMKBIhtFsVQpT8s5IRjRetUPg8ndchkrDzkTzaR8p0HiakYbY0i+xv
mj9TWrjkgQy5QacVJObQAGNxRXvznEykLTCOZ0JkY8q0EgTV2NJ0zvTOa+y5PXSoYSKSHfXHy5Kb
ZxQwlY00nGOKxdNBrMQotYCO7kRF4nV+/ZEPGHwWIWUj/4Pm0UqgnqpS6NiXFzXOvmXk7w3gzVgH
rR1NcgiQg0//0Rv63ngC1+AcpWloW8ls5kDWhW4RgJt91qh5Vw6wlLE2dbflUFyz5D23tRDt+j8/
ZFEk/WtrobVU27XiJfdZhvYeuCvHMaJbyKL9FYPWs58T/AZ2UIus+zt9VzWq1JZ15ylGyUfhCOtB
IRp3RbH67Cq2tHlbQoB0W33OHsBKZzSCChZvVhpV0joVQ23tL3+/s5vmr1VWutiiDRSwrLHzSijR
Hv4Uwd5hUPQZHa78Jq5BVpLz9VfOw5lPheGPjoWpodu4Cq8eDft4l56j7DwbNcQ9I/z2oUsGH+k2
SH+Xn+/MWwQtCsxGgV9Cq34lf94htQRAJO48bOpM2LOtcg5gJ5mj/+s6JrtBF3jfGAjRri+bMOc6
B9XC7osb8VDMJtjReQyu7In3qrqsQhopcFsz3+vNItUIWNxi5/mILR6cojI/+e6ojTdzFJseLUHf
vGLMvnz/t5coblS6xEdAt5GPX+91E6MTGzWixiNF6F5DizJDi9NkP+YqQFB5UfpPVIH2m2+aV2Rv
/9h0rNa2sUxwFYrjuK3ay7f9+0QzgIEWFs1e22vK8BI/h1TDlMGlAC5zs/B6GyCiV3fkYycGBKqi
TDGsm66DsnBIdLeirvJhFDOuR7XFSu0p28KQ8K1TDpkWPEGGCihDV8cNbjLbYiBfAv3epBDysz1m
UC26oyieAB1MZ/li17Mor1yf77cnGtcEBgmERuJcs/IeNNy0iKLInIC2JuoFmSggDXOof7i8Od+f
t2WVZb9wQ2ONtDpvdaIlkvHGxNQKkYFQG9qt1oemN5Rzc7y81NkHcpXruBIBRUSZ3n4zHaLq7AQ2
S+GWvU8kTdoFS3jlVJ97ICwu8I8TSip67m9XQT7KrWtXYjEIumg7NRbCBzNFHXyGa16DZw4ATU6d
NitVj82A7u1SgJ1zWIzO6AUUSMUGaDbqUN2wCBohX2iGd4isht8HtwOHa6baFF65WJa/f3UIHJY3
pA1hlRHB6gKjsRpnnaxGj3aJRjcxY3RbDOD26DjcVpUe75QorlmQn3m/Ds1AC58yrhl8m98+dOmX
UWy39eTFWoShhxrSvV13w14gevPvn5KlFpcEiX8HNpJvlwpUjIR8wt6M5fhFmmMH2YuxrxIyu7LS
2Tf510qrTdNWGgIyXTZ5LUnoMzAu9ZC7xQRtxuy9Co0TxrOOOlw+D2cXdRksCmx0dDKOt48HPY4C
2oHs0YDj+MGJCX5mJcWLk8PjzYzO/D4xhP1xedFzn08S8yQvVTr6Wi0cFlvAfCcZvAD+y02VQbzS
JBQIutX1lZd6bilHmRJwnguTYB0fUJ6mRB3K0RskkuCDrCAmRf1/3Ti4VyLRmTcJjkK3mIAQC3Cg
evsmq0kWeW+owYubvn1CQ1QcJqxDPjHlre4cPwDPGOk/L7/Is2tiFAQRjRgIVPPtmtFER9FYJqU9
OOGMAXCT3qYIzO+iEdkkFAJ0xH8m4OXydHnh94FeGAbxADdaXS32Hm8XBhaXJ6giVQQ9K4RMzdw9
xQHjV5F1xX8CiZLgynd8f2+zoNQt4iw2H2ptmVVz8IbQbCqU7LWGmhEluSyJmivf8PwqpLQkzyZ3
9+o0GE2OtuPYVl5WjCBJXHD8H9xYmVce5v2m5GFwonUIreb7z2bQOpW939ZePaBmBpCnmY+KfuKw
C9Eu/n35U51ZTC3RG08uBH0tZ/WpGHRNdhWFrYfcjnbbYj54CEc/e5j08prd0rLF38YCoUwMfdmK
i6XC2pfLHSyLgYLfeGXZVO0v1JqposxuSh+QJwRG3TOH7G9yBD2f8C9KqXQNQv3lxz3zCZFA4vgR
27GCW5cl6D/OfkJL1bP8sLvT2w7kCwSk18urnHupZCsu1RzuQdY66jnRXGAuVXRemJnhwZ+z7xB5
s70tgR9fXunMSVvONlbfNsWruX4ehgtDaIx27al41o/d6AQxPWykoBk/990RwdX23w2nqQmx8dUp
gQh965hQFlgpCIQKPL3WxieiAZpCanZvTXi6h8tP9yeBXG0ZAjhxhyO9QFmXG+6vHBoWYAgkBkkk
CS80u1ns6mqG5/B1NtAs5E1j1cV/8GWH71gRmHvuQf3FROT7yn125nuyYUwTAxJB3raOSICcR7My
FwgD8N4XlGuZWDpRo52mDLz95Wc+80Vdgdww1xmeSITBt49s21mquijqvAig1602lNYnv+oyGIAN
jSJEIHGI2f3rkhJEOVenBKuCjdDqDgC0k+dpFDceBhPoOlhqzxi22emInm/zAQL75eXen0GWw4IR
axWdMaK9ymTmgXZX2Dq1Fxph5yF/AQOUZ72yyvtvxiqkvYtdmU6vbvUeUyDG0h/82otad35AbMc5
poELznoRern8QOul+FK6rejVEXkUnlmruKBVEt3+TmOWXvfVTVOIBtCqXRwCK/rXhOXPUhx24aA4
6L4zbGQAA6CsTnUPH5H8RNLyBSbhsNC0givvb/2V1ist+/Svo2eg55AkbYE9RVgOh6Hz1U5qiHlc
fnXrmLCsAqdGp0w3qLrW9UkfTwaRojM8g2wEvVVLvQrh2h45u73vWyPeownp3uOY0uxHFA6vHLYz
D4lPl+BsG+QplGJvHzLBKBnnIgQjTfAXN7nmdKdo4R1cfsj1keYhSYcwKMH/hv6mvtqKSHkpGXGz
eHliwVvPIKZGiHjiIhMB8MYM5h99fZb1/neOYrIn4eW8fapu1siGfE33GAzq/Tabk/hLXduo0V1+
rjP7njdHHuQAmNHfRYIe4M+k5cqEzoKDK8qP8YzCUksjF9INogdXljvzsQCh8gJph7nww1bBwCoq
IORQESibLVhJVRzf8XFt7/JDieXt/B1zeHtc9JQdpm5jg7e+OMxWxRSzAPI48Y37GhV5SINDFs1L
VWrAwRy83SJ6KkF4yGUz4X1RmSbhdkYjEyhrb261IDLQP3E6OzoErl6f2NtGs60dF7BzNYcTHghc
q1DWmed9KOq81XbI66inGdgOrZtUE/KghiRyvyLLPDXfwtLsgWJDLTAZimFzcjP6etJt0ZPJwy0e
PTowcsCf05X4e+4DO/i0GTozD5uGxduNNAYmKjRolnqh7sTeDAFxE2tpQTMB9tnl137mjNA25bVj
5H6mlRTHqFugJj97+hj2n238azz4acOuk1353zj1V7yWlxiz+siC0YHgoCz9kXXB4NRDl886y2HS
h8rQHGS/sZl0PgX4VGyRvjUfEfzA9znDreTyg/5J/t4tbVGqULHQBl1H2ywN4qaqQF7R2w2s2zKX
0RfwEO5zrznW4rTqoGgXdsHj3GnVFzPrqgMQf/VS+YX5eWj77LGnZbi//KvOfOk//V/A6ryUd+36
bDSMIEokJqhhY52Cum1uEAMpPgGmi6+8gPNLMdpi+qqWvt7bTeXKGW0DTfGlWx3FyKIGrWNF+X2h
ATD5f3iqpUtv0gTifl8F5qw3K1zViZaom0BjQiK73aVaGD5DQW+fLq91ZgOLpX5StLglNtOrx6om
UpC4cWYPfMCcvAbkdp9GwAT3XYpG0E/TnLQrwevsilAbl86T4F+rFUMtiwIjyWfPGEob0j2CkgDg
8HnpAvqwaXDNl3rdTuBiJE4KiykBWdu7+q3ptdKuknbykjAwd6MJDbIvQVIBz8gAjQY/dVeof8y8
/6zJnuQiJuNh/LjaLCGQziywuIBzu3gGHALBEzTwsRjS6P9zqSX8/JXwtAXz66B3Jm82nTja51gP
fMgSsEEbLdXN6crWPPsyLYxlbSVwNFznBAgFKycEBuK5zWDcDsj7HzuZpr8XHP0pmMvyFVXc8soe
PXf0TAhdkhk2Y6V1aFtAeeXQ0a204B89jMgLHtuyjo5LSXclBzl3wdK2d1hMOspen/K4qSF+5+4I
b99kSBEU1QnGogFzMkEIbCD7wRQLj1KwuFe6NNdWXo7N398R6dNYm3IeEmTitsps0E/uhKTomLsn
ORrdrz5swBTUqsivLG2cW3uZ4XLYMLZ11mGlssqeAXzCV+3ruiCSt34PonGK+h0iwbGzxWgkHHc5
ZdGwVaCNvQmKa4wAv+/eIKvlGBsdLkC4dXIZIHANXRp1yGn0nU1tVQ1WRbM5QJQe0ATaX76/zu0N
ukAkP8wl5LtMPAsz35hQP/Oq1EkPg6vZO7QEUrJH3bmy989dXCQUukkex721rpf0HoFnOcyz19fV
dAiKsDlhllPs9GCa79ALmY6XH+3cWUM4kDEgSb5Fq/ftjgAZLIIA6Vevd33XPMhOdPdgW/zgqReF
6XiZv8hMGEnTPl9eWJx7qSBGYCIQ6smUVyurgDino3jhFdpolohNRPJ77eIB47UIBNVHCQ7COeDT
lUT7oU5C5A4qmDDgLEfry4COQv4IASUxEZaPYDb5hRycXYlfG+6W6A0khwYauH4qqj7+lCGMtojn
+GV3QEUBZQ2mvZgXAMqfP8WIkIJUmiwFkBQMm/zWBvCzt5CU2p9zO8/ISDgAhXbQaaqXaYhtBJqd
agSm3yGDd4uYjsA76PLrObMP6NkiH+YSU8i1V5f7GOcIAC53BKdmUTgrjVS7jZNw+AboNk4PTddF
1eHf1zRsGmV0+2n8r7OvEl+JsG81+vCFjppMVeYTm4/7YQ/s1Tdgr/a0Pv5f1mQOLS1X0NhdpSF1
QI94rFlzkrbPRzCANbfcEAdLG8ePve5e2XZLpFplmMAuCJi6oAnPdOPtfke1UPQ+QvRekOHfsPFb
rGy2FuLd1+AzZw6WpENtUSgpRXaw+oAuKrEw0bLRk4hAhAhP6IYGMj7DsRS91gSp/3Ce7+Jmir9f
fqNnzhWqaoiGSB6SLsjyw/664+chbpRuMeEzkRrHIkJFk7vHtkf0+960zCtDzHP7lD1qoC6HCg5d
uberyWwspwpmlVe1c4fkUYs4qIw0c9zZ7YyMiULE/MptfCaQMMiw2KKUsLR6VlvGKcKgFWE1g0tC
avO+TRa+sAoTBfAx+45s5r2d22Lc5k7rX4ncy+5Y7x6GpksRYFj4Aq+WRi8t1xuKVI+bpToRAtJ9
1gLTqx0Ze7jKypPCumqX17E2b8q+qq+87XPfVrmU2JgVCDp4q91LIzgjRTe4Fdr8g4OdkIfpwY8Z
J5bj5U1knFvJRkd86QC5ZGHLn/+1ixLkN4Y8qPiuJEvmYxhbtFahH2j5DvEe5iIbd87Ke2F3kIXx
fcm/VU2Vn4BqOa96lguwiFAdf3AKKnUTgV5pPeSV6SZd/p1njjNBC+cQaZJL0SR7+zNBqrS2m42z
J0PInGbXogbeQEu+sspyWFffHQINdHu6i/S617mLZhq4CKIY6RnE/vTo91lX3gK+Dm46PIJgLvdD
LSDaGPGtjRknIlBBPn+lm1vgUDomEFyA0edH3Y6A/tswjH81Ovhu1JVNgdHJbNrtFqExLT8i4wPR
hEITuy8/myB9xK4b2z+U1iB0iyy0bt5SJabTyWkqjJeVtJMBddPMRjm4bCc+UpSUiPC3XNZ3/TTF
P0YZlh9kFAS/zVJl7c4fjAA6r48J2xbDUsxqUMuvbwRidcEu09SU45IzmDdCb7L86+U3eeYAKVr4
xlIOMpBcV4IpIrKIJwQWtXQXmT9JDcrhvw4JoM/wrcPmSZeNFPcQpyeowjaCoUcbeHh2Jeic2dz0
8jk+dOZIR9dzBMdA9jKtDOmJArz7JrCMT9T38gnPwfHj5Qc+cz9SDTLpwitd8LzLZfbXOdLdOh+K
0sJTU+M+QdWtrVDViW28hYMW8ugzA4bw30sZGih0HwHQsOT6ggzmyIyQ/BdIQmRKnUgV3OgwmHjP
fJmkYV+bsy1nbHU4HPBAFlp6S42/ThvCZmKsOBvCywREbgFf4VgrpP9RXM8+A9weDplefrj8Ws/E
ADYRbWMlmWIYa5gQRaPdt3komWfbIE/RPFosxZ1seKorl7y56mlQBXNyCw86uAZ1PnPpYEQPzBHQ
Dtewu/qmQzZDvMdnETwqSt2QnFDSQk/93682gjeYQGakUEjWGLkhwjMFsU3lJZ014ElpY68dGtd8
7s8cBWfBAi1gTYb363543FquL0nCvBHZ+52LrBcWa622FwUzw8vf7N3EkoYF1Z+FapXrGry95b3+
dRZA4EPfxZrZq3sbirnKrDvptNE+0qz5ZE/2RI84a7/Irhe7UHPi3YzfyZW3euY8LlgTvhwtW37J
6jco2AfIS8W2Z0E4+pzGVou4ueEfCmewPuMPHlwbCZ97auDEcunomcBineUX/fXUTpOqEpqPWjLc
HCN7C6LMnMPTdK1yxxQJv74JW5xkGNFmDaIBU8bZvnLhnX1qh8yetJAfsz4uyaRPY5jqNiqdrjwk
UHO3uOQgWgWYYFcIO75W7J85Iq5Ou9rkol+Q2yv0I+z3VMV+Z3uwnWIHlRA3Qb9W5rvWwdLELuVi
d+1Ez0AeUI9y9AY7ezr9kxXXm55m7w4deucYIUTzenkTnvthdDwl/lEmUjH6KmEwCqToB12zOLuO
fLZJazdW1wdXnv/Mlcib/r+rrG4IC5UkTNAj5emJEeyJdd/wozc/j4P83iMLfNMMrbiSmv4Z8ayu
YQINs2pmulBo3NXORqKeNN0htJZ11mmb0ta6+lDkY4kNCk7Amxb7Fhg6KcoBjzmiFrCUSlSG7s24
y8Vdorf9V3RbpxPuNn7/NUo1ie+DmaPCMyGXglIIGC3UFiHqBtt6GJJnXw24GCVmr7Z0RhfKvJaO
r0xvNJwPg6CxcOWzGnsXgVU5hkmLEJvA8heuIXL+WMXUseHvcCSx/GfHH0EkFWLpKAaA8INdMyDw
gN6uJa8Nb88eSEGTDyYq1AZdmm8PpI1CFurSjaIJVkzuIY5J2I51ZevhyUjwet00tXS1jTFF9slQ
3YQKgwnuFSpW6Kvj5e145vpdhjrsRsgjwLBX58SNOmNxe1HezIxhH6sAW7TYxNTLzfQrd8CZkMlS
9MQXkPkyK3z72ImVQDByTKJWEIW/EthNSBiX+BIG9XQP5W08dYgR3DDMt66lz/zN65254BlonHEp
MHZdrZyhAhpPs/KaGQW43DL7rRyja1Oyc6+S6SeVIVkWdl+r/Y8S45REjm15wzxikhgYGTdbLD6j
Wfvp3z8aNxtkBgegFBnk2+fBNQNvGJERmV18npMkKr4DthX3UQuQ4vJS5y4SusQYSS/JKiPAt0tp
OTKDZcn+yEZb3ASWVr2oLDPvIgrtO3NEhN1W9ZXc6tyLdKmo6MlwOLgC364ZxCivxbiQerYIOnuv
kYRldMr6co/ISnylIDi/GMUAOGySVnN1GGXtVhm2PZYX4WLOzVAsquZGfELnSV45AO+XolTVSRih
4pEei9U2nKLIwn6ZS9k10/m2qieUq31r/ljO4bUu7vKK3u74pSoWuFPQyiXVWC2F6EPCpWpangXD
Hl40QT5D+fBweXOo90faWK4x0LkL5Oxdw87tQz80u1h4Q2BV7nFkXmF+sLpiCG8xfMb4Bzuu7nbZ
V79y/CoQMiasohjWJC9YF+ovrgRRuK2zuEK7yohNBuZottkowOKhhvVC0xr1LvZb53W0FaxzIzTz
3zOsho99CTL/4BdK0pUcff+nSmExbjQrDD7BESuyOwdJNGcTd/QbN9ArNGPr9L76mXaJJY4RSoE/
bQuVBQSzNes/HHrFzxrDvkf8VJ0fLUK7xZayFU+VpDdLDA8ruzmGbtnZL7DMaGsl81z1z82Yxvlt
gmHDhzm3huTg9+X8C+fEOjv5BZL+u2kADISmZmW+DPDiQR9V4Hu3YLpy40AfDgcYmeaD2AQIBPxM
Ez/s98UUt8iFkDDfJ6WmMM/Lqla/wX8RYUBDz/RNZy/K6qkSnboSxs9EJ0buhHB7KRjpaqwORNTq
Ol4KifDIgnFmROvKDX7oVUg0pLsWOXBmkxgPy1C5KZrotDIRP0cmEk0Fp3TrK+nSn3x4tZPBy1BD
Guxkw17Xkn3bD+hF6swjsvCjgwUzQh8xkmS4B4/1vTPZ7R5TZxQvYiZWhSbdXSjDGNEhIRgtacgH
0UZ+ubzvjeUdrH8UnXEIWRQSzF1XF/CcFQhLpoXpyXTqEtRCMAW+i3JkONhqbvDZnoGunMY8QpOl
QQA93mauPms3UHLa9CYrszE+yCjDmPLKD1uu4/UPY5ZMlg+2m97k6ocx9QJeOhUIVoVF0aNL5pfx
Pp2Gyr2fXL37PmtuMm36JnGKLYKOervFoAmLq43EPOzVzNpRP2moPYmdwB63RA2ibb8zlZ8ey8jo
f13+tWcuKRM4j7OAqUk91qWQhaMnPqi1YEae6R8TbErH7SSQcrzyVt73fPAPJoJRxNJ458W8jSd9
B//KCXXh6UPufk37ACMHsJuPgjwVdRtMazKkngckiMYmRfaowlLBuIIHeB9HCS2A/dEcoV8IRPDt
b9CgfCMUVHEh8x8f+aQOerGZicoIyvEB4raTe0pBQ16pA869YqIAYxww8Qaw57fLRiU6Tk070+6a
exPf3Sy+oWowrxzSM4HNlAIUAC5bgvH16gX7KQR+qCjSo+2PTwhiKe7Pzi2DDxJg9P/i7Lx65DbS
NfyLCDCHW5Id2BM0M8q6ISTZYs6Zv/481MXCzSaamOOF4cWuoeoqVvjCG+Lju3cNWQZxJBVoKGfr
+4mQvh9zxLG9osw0b8If5HVu42Cn0L2xcGSOBkVdWq5gHFZTqgYzj9HQVTxiyuDiiyjbwOGqnu/P
ZflTVscVwAYgPdmitks6cP158rk1fGWoBi+PfN/6Yw2ynrjQCVT0LxsO4FNOq3pnzI2dqEJhgF9M
ZHDbBs9nfTSNAtaXVCnNj0FcQCmojNgG6jpuiXrg41Rg33d/osoyk9VMMSzQqHxAO6Fat5zR/xQh
GgWv6mhUeq9PsDZ5yuQKiBwS/TRLQDHVLywPflb4i7aLhGxAaxvNL+0QaE1YLmLxUHKGMsRBJMqy
WHIDNBWDDyOk4s9DNNPYWvAZT0Za5fgXJGEpfQoD4h0bDP5itJxw4f5UMFlJvpekVj+FNpSKc8KF
0YDfkiPjOKQJUrEZoXXwlpp9ptthsc/J3Fp79hRwTGo/Il/+ehWM0FIMtWpbL46V6aOPsQuGIUgL
gmJp5eNIxRqLFKka3u6v/sY2W3pxgPRpyEG3Xc7vfxY/zCsk3FRg6xLcqZc0QAUdOSDDgelqvnJZ
tTsX7nKrrD82BUqaj2S3Czf0ejzqXx3RM/jxaAy11yGXmt9Id4UOYglIj9bt/Bt8TeUg+pTv7LON
Y0tiyR2kkTew0qttppVyU/o1Tc9ORYNcRWbspAXaeLq/ntLGgjICp2i5HZAKW4XX1WzGQ1XqUNOi
DqWSVvPF5qzHkuzp5aAHbNgimW28iwTBTVEfmh+0hj3xscN5NLGxUfbbf+oAo4AjF12PvJlcy8B9
CmH4LONBre783o1tx21JI22hLN3yiLAZwbC4junaofJAP1gvX6Y0RYS/b5Wks6PaT71ibFPLvb9O
W+NyRQMgAOksy2ssSRkr6MUg9u8JhVGe066NXtW6wAi4T6QPPJMNkqx19OX+oBvf5m9hnLLfwopc
N/T7fkRTfaENKuZcopEoYvtk9uZh7IovPrZT3v3hNnYcbn90Y3lfRdrQqyNd54mo9vhXek3Tofhh
9BZ2DGqZ7uExbtQwgCHTdF2iTbgFFhfF9aGatYr+H06WngYEenaHQIl+5pSXFnHffMILOaxVT0LB
twebkUQfRRTX5VOvVhpu57I6/bw/741vaxDSKHwmgjcwh9c/Z/RzAUVZsfEifDbx8E4j47VkH5/a
Ti4eEtTF5IOUhsX7qyxLpMixUJZve9PsmZNEjOhHQCTskQL3fTwU0yRozj1hweH+FDfiRsSXKX6Q
2FJlWacekzWRqEZl4xVzKDlaoEt2VYuWI8ZRexyV0j9JvtgeI87SMcRY79P94bcyMTYVrSTuUgoU
awRHPANpj+Sy9VDMmH1XNjqUiHKMCl4i5KpRc+orDWUhg1fjoESpSok1loKvYoj2786NvhHhGcSQ
RLDQBIEfrO7VkRQbsUcIOyO+064OKEe3VWHsarfpi3qvqb5xhLnBIS5wrkCgrZ9Jkl0QW20DpWso
AOq1YXcmzepsCy8dF5H8fCfn3ZqdwQVJJYOvTaR8vZdDHNpKxYpbD6lmuNpVreApNOZT8B1Xjkb+
cP+7bryOdGRJz3io2Frr0ejgl4gn1i0ksg5fNkFCll+TCq+LJeFojGgEj5KhvVaIQO3cx5rMRK4f
ZmotS9jMNJcG7eozgmeJ/SKFNwSxL+Go9oTqrqR12WxTwxDpf8EYeZ5Tc/hoxSHeioVqTl+R/xYG
F+ieT4ndNH39EMyzaaIFXYpYR5n+gG7e0DbYPMzVGNkTLgqSiwhUWR+aIUWzrglAx5zMpBgXHfUZ
TdBA8aU/mYUHDVKOwWTYhl8aH6WyEVJ7RsLs2e8k7U9iSEJ41EZaBp5CweRTEfhoAffY3oPsaLqP
1oDuxNGCn4H6X6sJCh9vwq+yNwarR+xPT8DwYkrmapAREdUJ/eFPEaJr58HVaw0H/xctd2skJn1H
wjh4DG0tQ3bZCapQ13a22e2H5ygD4aRWJpGTrSEtejzB70OBzUM9u1Q/LvoL1h9strrwhEI68JEw
q6GYxNy3vk3IJu9h3bZ/AHERZQtRusH0VUGItZsh8B7rahu/zQ1gGnSKm+opIJo70TCKn0FzNB8m
iKTf7u/62zNNvLT0O4g/uNT+Xnb/iUGjhkbbnCgzqsu8CaKBvKiIoZw9oJ1ynAbCovvj3Z5pAg6C
QJaadAeRmesznSZGWOH6A71AbfJDhIb5QavFf9u+G5z7I92+hNcjLYfuPzMbZTmP8K2A9tdpkzur
7YwRU18dce5LjijU5mzgqTrdH/Q27GBQTrEpEc9TilpFoG08QUMPmZ7sU0EdIsW89GNS7wQ39Idv
bwyi6L8Fa5q3Nxd/nk1DS/1kaZnH+fBF6VG5/WFVRaL8LA24FA+iGsrDCZIZjuptVKMw7qN0jVB8
irTiQW1kq/IIVRJKUqDVYrvUp3Z2MeaVE4xgs1mzFaktKzvFIGzRzSvL+CG2UirigZ6UHbI7QGpd
Lpqu8ppSTfsXYotZxgHA7P8pVR9CbBhVLerToT8LGABI2GRWyWj0bhU23K1SI7Vof6d+npwCXO16
yDOT0r0IoUEUCpY7HD8BAhI+61GMJGaQBl3woPUm5nI4zQd/cIdMDFctEal1qy6i7ajqYWPPA4KD
zowFdnyi6F8+086O0sNSXZpRa4n0DyqNkhC1kTb/XRAkHlXNl15NMO8vNT/+QR4sKXSDMBBxrcQs
rHHnmVIEitxxXD3CY9aoOqP6/kVqJTNxQrzIRqbXys9DK83xt2bGps6mLN5SZvcxUuV5zOryhxl3
Zv2rTQuKoih9WeGDhmDg9DyLQvylnabQd6uqGYojSqfWqZdzpf2NLU70Eb3QLDnpOvrQZxMDr+JF
LDgyv3NqAjXzFcoAe0a9AbrVzvJH1PyR8GqGLk4P5Vh2xUtcwUhzxFEzo59yQ3n00pg1T4vAwiiO
lNUyYoZa3ltnpP/9yOPwIhoyY7gBebxskZ9Pamm64Bprmk4ewrz7kLa9PgCEzrGRMHH98L/rZaxf
2lbGz4vKOLV9hXLvN0Grm556uJSMn9K5lC3XhPSifPCjWC0PkB2yxDGQbTa/DAGIwce5Ajb4RUeF
u/gZJIkg2bJRt2elRnaNWr9ojLYaIw76KLR+MNjj2BFdzfSr1Yd6jtT4HGRFTT7VACC30QIWJPyw
Jz3CeXuumiM6ibx6qVnTABBjTSm/9k1kDF8bTWhkO61k+WdQKWHzUEQ57h9BE6JjNHL/iucJ19AR
P5ElnLNapfigaTrXJJxLQzxiSiGi46ijyztmoHpdPkReuy21+AjdWV1S40Nb45YO/G5OL2KBHbIz
l5r8A4s9HzFdjPSAx6bt9IqRFh57ZoAtlYVas8J/1cenIkumCkXNPOycBHTFL9+vdWpDSRaXD7lp
jf9YjRHxRg0ln51C1Ygxemhogme0MBTsFK/WCLdRYpxDijOEbpNBYMvH0yynTtObrYS5tqn8qjVA
EAfaPrT38RFFaikL2yZzA7kWIzcfhSg7S/jxZmDVfAT7o9KKvxT4GT/o+LrRETf99FXUWl07mDHg
9At0nn66lJYUNUdjNnyPOzgZPpBJRE+4jYjFKR30tnaw8OZgGeFEZ3EMpyx4FKV2UM5pKg4fUwSX
fsN5x11XTdEddWZN70J3GPoA+5xSiBF71OsucfwGbdATjgPz01Sb1QOrxqLTvqaPVdF/yuzJFHPp
MMcWZo8gUfTuyyi2tfEPLI8OK9qmw/CLd8HHv7qWeXsnLV/M88CDwN7iyfonx99D+j3KYv9ljNr8
RUpl6bMGOyY4RWEaecPYZJI7FZibPVRdVdcn/gjF600yL7uoNfo16APtBa8b/RhqlUv7csmvrZvy
q5mUWhSnken5bRRURHOheVQzWf2pohv3MVEn5UepaelTXSr1UxQF5rEJZH2wjVoLfwR9PvoHnEFR
qcdoQNrJSf/Gr6v49m83kp8HuJ7q5vVTjCN3gWSKqXtDZQaCg3eG9kxZXFMdSkHWJxCf8R8oFxp2
WKD0SnsBxdZOUw+5jp46sBCb6o1RHlHaE4qT7veD5PZlECfH3kTgyMVHszbdwNLL+mXIWrlzAWlI
xkuO25XwYZpnSPDwNxa3ExJYNKXRHhgcukGm18/1RMUtTpTfNA47+fe74wE69EQDwG9ACK8hDlXR
zxNqI4bXVnl8DrFPe5jFvNtJIG4zYvjd0BcIYyGF3KyvZUV9aQmKQe19KN66qU6+44OGN7cit5KC
f5kRXvIM5WlbrqvihDFP9fX+PDfCSMSgkI5AzkG+hXIIeiSbYycgQuD7lcPNVh5HyxofcrGeHsQ+
194f3CHtyN1KgwPcu7z8nv8Ed22Aa2Fbst1jUv/XGrOU0SZQSc8+11Vo55FufZoKv/tyf5ob4R34
YImag0a5+AZ2gZEU4sfJZHgWciMudYj+0acve7w/ysbnBEICnYBbBQzQ+rh0HKLW8tk0QqpYqU3e
7+McHg/Kc66oyZe6CvMHVSv7R4wjh7e5nqudXbsRpCNdplPTkuH7KOsuC+qMsdzWrC4OQa3bKOBM
ywAI9IgF2vn+XLc2jgLGlOxnKWGsQSUiZGNx7GTmSv3T9vFmJ+vm3cdAwHqWILftHJXNqVGfoj6M
tMRNgC7HTYM3BUdFksOfaqBXlzm19LfUn8WdmW3tFW5jWvWgj5YL4HqLAoGQE14MsJVBSP6bDtKz
1g/T2/31u81yEAKhRYUtK4Q5NH+uR/EnXa56aTQ9rRHEhzgOBCxlQ4NFbMszTZ/CGWR2z/1BbxcR
IYC/dzlkl4Vucz2oPuNxn/TUbGWssZDaxK4DjIAG0aCXDv+foWjLs0No067PAs4slS8ONZXMKQqP
qHwqdqhq0ymL/XDn2N1+MKqKQNFoe3O2b4DVOLdFIbG76VUhpImqG+cnEptqp8x0u+EZhW4PwkOA
MSmkXa/dnAKeigfV8HisffEAKDdIbSXQDDy/hKy3kSlFh/39i2hBq6AgTsOBQOF6TDFuOA349CFV
Ky9hM6dAcoi1BEdvq2GnnHJ7ewFL11GORfgJQdB117lpmrDFKknzusWMwkboJwjPQ5XGQJsH4Oru
OComVvIE7xgpg/J0aeqO9c45/6vidR1zKOBTltr8Ugu/gVyITRTXPmJ+njIYueyCO9Hzj0NS1t2D
mVMidcBVW5mTkiJ96jE0bTCOErGJhrAftd9DpGQHtxUwpTrDYMMxTES2tXqo4sFQDpMwYFMk4Si5
x4be2IMk+8RIOrTbhYp4/aXS2RBKohjVawtpPkSxlOElhm/Gu/fDEl6h9UTdiz2x2oMDnp9WHVma
ly/Oy21Ck8AuI0KuuUrlPbmi5Z5bfQgFaT6OFGXjhVNwPaUY25U2EGFFCOTETmeN07d+HowYj5Vw
elEJUiunCw3xMVLaXTWLjfVUmCGNGZFqCUt6Pbgi9oGS6IDsK4OyXTDpidNO2t7N8ZehsJ4jCs0s
porOA9D262GQQmmMuupMD5Ha9gkCHtObME5/bWQBKTrykkmgsCa2ckWWTpQG9SUhK0hyQRng94uB
hMm9Pv+EtQWqjcprQNhWxFJho6vQZtjnzDmuIdT004OZxPWlbMF1O9imRk8VvXRQyElXf9d7niPc
pUKz612Dp0E8wL6zfptSi8gW7rjKs5WR5ZP+yULhINuDI7cy5wjc4hVh7YQRW4uv0Y3VoBzBplqj
nrI+8/kfY9MzuyY9YF+tnBVgOO+/3NB8pAfCrUP1VF69gIUl+nowEnpG0PGdsTUSDAZy7JSqae9q
25wQkF3gMX9lPVbFy15OuWLxtSR4aESXGrjmhkRyO9W9jdd1IU39b5TVhCjoxZWqJiybHM2gdsrs
GIx+/ynGR2hnqI3ogaFQ01gw2DxLqxjFH6K0TILQ9DpRGjBfnrCYJJnA55La0KNV0ayHIW/shA8b
TyD0JY7jgm835TWDyZ9bDMgkipdqiPeMls7DURxwi6ShMB5qDJRe7l93W5+Nto6Bexj76wYWmIn1
2KvDYHgJa/k846/tAD4zd969rbVcWnDcrLzr7OPrO8BKQQxFPTpsVCCt7wUW3xamndRVxlm+lM0g
ePhG9Xty4hubBX6duvDsiFhuHgyTEl9ak9p66YjDR1QKgYfNG25xVmjuhGIbn43bm0YcGRDcs3Wo
ye0OTi8XLUSmwpyEJNHk34IijM90edIn+JTZDjhvo9MKSA7lX0D7vBw0fa+XdMTTIcCJ0Peo/gZP
yGoZ/wCUVL5Sn7I+jeAf3TxpuRDnxHITOdNfq7jwx+P93bMRz9CqJaum3g5oYv1+EekUCMEVwaXQ
Ka3j+h4PD3M8jciTIErwJSTDt7CqCpPQseQ8IIKT8jLaueQ21n4RvcE+inICIperlTDCDO40CGyv
lcR5si1RyCZQoML0J599rtRQD4ud23vj3Safl5H7AlCA2tdqP6sauqHhaAlY58yRN4LfeCmwyHP6
aKrPUViNdm6Fs90Tbp7ur/jGeYXIvqAy4b4oN599CDKttGaKl5rRGi+Djn2alVvpznn9e7mtHm30
2dBJIpVZosTlZ/ynhhDDIg1mqxIwOhhFCa91hKh6Cb9POxnAGNhgucV/RcFIXmKI0HhZWVP0QcRu
9Kcszdr8KQuT2Ld1gsOQkFqbx+ciyorMBl+OomwpVbrkWELfYsgSCJF0bFvJ8J1aikVsg7rAotCJ
vfx86GGyPjYQK5Ep6VJpgN2UYgsW6pOJnfoUDcljn9JnsHtA69q5DALpEzQGazhLoKvpbQS98tYM
jf8VeZ7ora3zVHYTzLmbA62UsD1NkGBfZ2SvwIgPiwd4S74KTH2qVIxnk8VjuI/U8aOeQNh3EpT3
RozTO+kDRhM6LmValr71eZjpLr6p+aeeaA2PR7Mk0mh9AaMqLQJW6tRjVgPHrFqjcbPeKjOnxX1O
t9tAwmROoz/0xjPTA+0vw7qzw26s6OUUY/6qFSFGTVgwYB9u5ukov+QxSkNAxhUsU+PEnC45mcqf
TGvlP10AwLucWOPDEHTZD7QoE8seKWc3jkjj+hdEY+VTnUXZL1qa/veuDurfZorlwiXu4vkzxCq8
8EymWqO10ZmP8GhhccWGkB5xCaMI6VM8wBgTLakUXltsqp8zwdDDnbd34+Zeom8AWDSeFw749fab
OrNRpK4TIJtHX6dR1ukO1JJ5UNU82nkAt4ZCPhpVDOJwoqRVRFFhcczPIFAR83x8RW+leMkx17pE
OLzuPBIbZ3eBNMrIYEAOuHlrafDFPt5xptfSMTkneHs+TzE+WfdviI3r0FyoENqC8qO0ulo7HT8p
rOsN08OoRPjGB6wewsgSI2gqiknKVJhF794fcmti4FBA/oCqEgleVp8rboKYBh8V4wmdDcHo+6dU
hrh6f5StL0Xsx7pZVHIpeVyPYoaDVEXgxb2hkWY36bPRVbvhN3CyZGf7bc6HGxbC+kLIVZZn7z+3
n6oLqa6HzMfAkPqM7SS+pqW/1w/fns//RlFX8xFggeZpDhCNSljqJMhdnGgcRU4LAfZ8f+m2JsR7
RU14UbdB4+B6QjjcmwkefhQ5JHzqG2oh/zSCEf969yi8v4sL3sJMuyno44BspkIdWl7Q9NlBQRju
KBVF/v5TBIFQ5FECU0dIuVq2GO2HDG87CzOAyJTI0AbfOuMrPbQ7i7bxfciY6HosSqWLFsX1orXi
7GdZU1PQLrvuUzLEAAVkBdE0uuhVsBPEbA2mstPAV4HpuuEjyH5P+aUlsYGM4btQ7EHhNv1oYya2
ZwW3EbxYQIGxRaN+bZDpXs8r0HMiF5lCfUr5Q3Cw9aQ/7idmrNhTIZQtgIDe/JWHmOBJ5N2v9zfJ
xvWEMDKfjhSH0Gl9V4QKklXZTFEW++rMFiYBI9AhLFUotuX0CSWTYOczbk0XNCIcXPoF/Ge19+eU
QlwMOMNDDSL5De4Xn9u+8WeXdl/6LKRgMGFkiM9NXyOLd3+yW18VmgQNUpSlKAevx0aOLOqW7Ap4
73xp9V4j1NFq4wn4hyrv3I8bhxx6l4LFCRkBIlqrwRouEH82CgNUXqAfasXKns1MTndGuZ0SkhSU
1KluL0279XL2SoenYtP4ngXc4QyyobG7Jiw+jMau7ccGZw0EMYJjGiwdi6rpakYATCW61KHv5RWF
HpcsfQrdpWwUUcZQzM+kFPXg4BerD27TZs3oFBm+57ZaqjluuKpKfHgwxkbfg9ne7qnlh9G1hIsB
Z22tACIiKaQ3ebTEJ3MQHKl7Jr/QFVWPGA9LJep6Tas68hTUkZ0WuKEe7m+rzeEXIBVlay7b9Rka
zQKfDVHyvajrtMzBJ3vq0TMC/WkLQVM89IOofAUXmUaHdkDK7N0RhioS5lEYQaqb62p1gRQ1XphY
bPjogcP6wYHMcnOx7A+5bylvWZDs9XE2cl0eFPJqE+kY8t11ulXXVUXbrfA9UcFBvVdb6KRIHein
qcPitJNa8aBJMeYfpTm8YFuMq6Q6lG/3F31r45NwgSChYGrcNCcwWOibxqoFLxwHxZmsEeZs2uYH
OTe0nTN2e5KXB5SSKXfGwmNfLbCRNHpQDIXgySPOFGpMPm3ImfL/2EU0MBFG4+FZFMqv3wFjbrsy
z81lVePpKEop7o1tHh/GBEH5DscUN00GxY0MVBvvL+XyJ19nl7zfmEMsGpogptZFrrCDmOfPqu8h
96s7la6oT0FX5Y4pCvkHgQ7E3uu6IZKtQvtezipj3rYCMXxT8fdqLW8GHrLkbVki/0ASLKjetH7W
s2OedflXo22Vz02fq6ljYGRvOLlvRgW21EX9p4e696oUDdWd+4uxdcuBhwRUvYhagOReTvt/ok0t
MedUrEv69amWZMd+SJKPoh7LaLQix/d1mESpPMIdz3+IghWoNor4+asSGXLtDp0Rz04llFKyswVv
KztAUAlHOHXaUmda/agmWaRQasPw4kh8m7rssUB9/BRZjXaZAik9EB78g7X27AZplX67vyK31ULW
gb/IYVCLuLEB1HM5VPSMamEg6U9dnrhJWDsAkdLntAiBvSGveb4/4sbZBh2E3S3Ppkk3RLn+BEHQ
J4JSVZZn+SEAcEvsD2Eqif+U0vT+1jeVXYJKnjPEjHlBrofqygm+F1AeLzIy2VGEunOhfLU7n29z
QjBNFugLolvrwCOJFIJUSjAeMD08TEn8yDCgGn6cB4Vk4/2rp0Fz54+hU0hYfj0lBKhk1R9JoQMd
UCHY09xFD0fD3tnfywGXbbe6OQBjc2Hx7tHAXLdNxALWuil0lpdpWhed2x4Kme2POGLYeE2NhSPq
EUh0uTeDjyJOj3uHdePmYnzCLHIC/rFGf1D7MAmxuEdEU5hdE2LAYVbayi2MPnUgre3Jem+8BADB
mbBBwxY6y+qOhn8qS9OSzHeNNjyRDKmI6Ud7Pc+tWVFsgaRFQM4Dt3pvpl6gD0Bi4gWTpUcXLZCK
j1mkcA2LpeF3B5SG3o915xY2aeYiSbDRdh9wkmzkgCzOGJR/ZbGpH8ts9p+oxKV71M6ts4CgLHIw
FF7wMVmt4SRknTWwR72xFAf0XJE5rqlJOmKI6t67TwLdQcS6wX0sQqCrocQZeIQy6YoXGnIYHuaB
zgclM034U4ZNku084FsvB6VZaFbLxYW0xmq4pJLmYUa2yAPZWf0ZMgUlMHDHYmLHKTnyaZqLYnxT
6mFGZD+oUYfpLdjTbpLINVXYBjbrYRRLMd153zd2rQlqghIUe4lqzeqOQ/2kSrIACn+qCvXXWQy+
jlouvN1f641BrCWtI31DmeqmUyaGviJh06x7UikHjkSl0BMm0P33R7k9GktBC6gGOHbe53Xo2fiV
1KkLqq0zi/JV0Dtrwqor0kFjzvHPaArUncv09oZjwEU0lUKKhvbF6iwmyFwajYTYHjw+/7XV1ew4
Rlb5sQA3Ys9T2H+Da5Q7Vqw1O0X/zakuDz41PKDZ62u8kfxWicXeAOQ+TicgRSXNJEV3ZAi3dCKV
96siINqu0eTk3aARfnPrJJZOh78Cluv346kYfelc94Px7qcdrZ+lGCWjQEwMuNqLnYzKJjUiw4O8
DM9LVILHvJ5/WXJfvH/9kCylULTsejruq2dQNbo+kQfgeshky89yZwGLbhuEZmtBOs5ipO1UKW/D
JDqNEGkQzaNjjMTu9bNbG30c6jCvgBCgdh7rUX0YUZpwesEfL0KsTg6qPe81K1fBDS2sbJ3XiGd4
3fEDmGHJc1PSU60t3Y0KXEHYUOVhkXz/fP/o3R5wIG3AF5YOm0WesqrCAvbpGH/0z6Meha99M9Se
WUrDnpvW7fOwDMMTi9wai7hmBU9Ki8Al3L5zYapC6QiSVLhQErHeFeVkrwWwORh1L/CVywlfiyKj
iaxyNWb+eRL19NR0JTZMeuWfQ6nagwH/7XtexUpoVtLWJyahWK7d0NckPM7MTK/DizCZgPZC5DmM
g9glCCHVk9r+nrJyGN0CqXXdFusULaJOa/Of+WzF+SEwtBzJ/nGsvuZakf075BSdjt3cTQWVhrT4
FTJudJSrofIdVeuM1InnCjDsqJiC8UEJ+GayHQTY1NrpHKsGQkdRlzpFXiCvm8lIo7lzlwS+y2M6
fVUqv/p3mJIYgDvArg75KAAd3OxTZ+cLo9VRUOPi/5zzIT/kndH2Tjn41QdNmClxZXMQYlE5K9lX
/gUUsuY67//McVCfwRVpkhvmloRB+9ClED7EOXkbZxMazDs37LLgi3cOnVkqjeucCQZilvsYH138
sQlcWj25l8sAHO6PcrOFQGByAjmDZFwgCVfXjBgKSBS0o+A1YMI+q2KpuOksdc+hz5t+f6ibE/h3
qL9qEYx0g2U1Q2QgNA10hlE30UHpa/lhzrM9EMHmKLwD1JOWssA6pp/TrtPR96CYNqTWCXaCcMjh
r+3M5eZ1Q64F+ZJF5BMU/k3Vu5ytOu5NzfdoLsoH32hTRxLk6JtvdfFFrcdoz8xg4ztR5UY0dwG+
8aCvHh5aYY0+Y018wc8bvdpGNE4+WDw7DPu9rOgW0MnkcJinS0EXcxG7v34KCmmSK2CZgjeHfvWZ
zFJp3aWY9ii18dzbFDf63o3SLh2gOs4DRyXU2wtOgcFbLMfjm5yP4sdRU9oQI7pR6OyikGPzwMHN
f9F6rvdaXxufnFsJnZXlvuVzrNZGmvV4bKGyeUaWx69i3UU/IFeKO7JBt3YpLAtD0O2gDQo8Z/VC
SkEipJVuQawyhYgmfBgMFm+yQoox1XDlzkk/mrPd+BH6rBNmV8I5oGmPNbjUmj+zyFLCVyUPhB6J
9177hgEQjKkQqSjlnORJPdn0H1vjMIhcng89ij2Jo4VaHb5K/phoiMVkeoyGrNxqJyGKhMYBkp78
zEe1n5ym18ArIouZc8MhL6gcNKOrqmOooE9HqVsEawHOaP5DFbiC++b78p4x9NZXINSU+Zu8CJnp
610jaLGkYVdAHTdWQy7baroofgWh9P4tsnUQFp4P6kEond/cIn0jD1re5b5XqUL+u9OU8KmU0lG1
9ajX34354pMDMFueVoQ4rXVKJPWIfFCe97007hNoh7Nsa3KaPYKk6w/353UTqS9DwZOgUkXN8Kbr
jYp65ys+3YkpGlVn0NF9yJLUPEzi3D82FLZOQo6DTjXq+r/3R74pzjHyIkDH5UIB96Y+3IcoVQrm
YHmVBUTRLqdEO0cZZQGEGytHMNFjlPUUeF2mzQdoYcVO5Lm1cUBLkLgjCsWVs9o4gzSLPKeN5Wm5
H16GUJ8d1ACy4/1Zbq0vCAaRoi3SA9CnrrcnYplzr/mC5alGjcQdqo39KdXC9PvC5TsLwvCzHozG
AZT37ooB60vHaXmO6HIQG16PLBSAtzDY9j1tmJVTWSviaQTlBLq4zN9bMSB+5yxzMuilUXtZlvo/
xd9G7VH4W/arb9bJYy6L+UNedcaxLvu9zHLjq7FVQYQsSsa3ZbppKdGhuRJckBNvvlRKsDA+s35H
vm/jq8G5WfIS2svkCqu104sgnEYVATqlN5M/gdwPp7yHYXso68H6MUuZwr2m5eEpS0p/Z8dszXBh
cfyF6y6douvFNBLBNFu6YJey6LQT/HtlcEUVOo57f2cuc7iOrIEgUwsgQacnRa36ehyrnZOctkFw
maF+HcCZn+esP1hRO54xMdmz095Y0YXHBIeQUge7ebWikzJFqhwG0SVUyuqQpoZ1LLtJx0VHjz8r
lVx5spnV31oIJDub8ybDXEgqUCY5flxzNP2u5zkmhYUIZR1dUh2M3yj12qlN0+QTjFnlIZ3rP/Dj
/Z2Cy98berW4gDkR4MKhgsbU+gafMh2YoZGmF6gJpX+gtiwgIWQWQWMbg9mNh7YpsvjYRnGhnP1R
avpLBqIN2FofBl9TbHxHe0Il7jdMflmzezXKywNlf2xDZKvT7LQpmtZWerap3ahCcJKEUVfs2qo1
k2tMEz+MoSKll7rX2/LShLXf2oXR4pUeoX75j5lNcAkEK/L6sqtluyys6BlsbfBNx273mx+Iw58o
EPHlCiqwXnbYWvJv8Bbp9xynguCgIwYUPmsaNrxtoqlvNGjnZ4MNC1l/FvXJQWi5+nR/v25+R849
+S2I1Zv6bmXlUjekaBZQI6fvlc1SK9mZbA2a3WRBqZ+GCbc2Z4QwquwcyY2niqSagbFLpUbxlx3y
n/sNvZYIHfMsvMRGl7antE8CcIxNoGpvRdLUT2z44ZcAXvoDYXEnP6LtSl/r/vRv66Ts4797aonH
uZxW71UkKWk3KFF0meKkTV5TjWcbPCMde4gkXEt2h6Lq7AiYJv+CoT6+jBgUiS4E0CZ0pMroP869
Egs7GcltW5ufhbohuHuk/6DIrK4rfRz8oGm5Kou8afoDAzWl01clzJaRJqRkW5kUaSdJ6svWaaZK
S22t0dXcNlNV2skqt74TkGIEpRQ6OTdIFbUDMEE5ILjIOCe5S5vzEJeT/5ymYKz8TMeWVchzNxph
oyU0jX/f/0TLVNeHHsAifT/0Hm8TGH/qi6G2suCSq3Vlm8KkPfoE1TvnYCMSRV0cFxNQamzKdV99
MskAIVoxSkCmCewJTRRGOQ7VvHd1bg+1NE9p7YLWXgUvpKGN4VsJT0QiW4e2G9VXJZYGFw2LaicO
3R6KYjvTgqC5zp/LoCOKiYPgEmdDi5WVqLpZPs9213d7XeHNLUs6i8UWzpcL2Oj6RaiHNMwL/A69
NE/0B3Rn8oPgK9onRcib5zEqUAgT89QRUQg9tqME00vx0y/398rmcQbxTyaxVCJvKP0VVmJRKBHI
dNJkfKfNGREDV3X5oRHTGCUTnGKz05io4aL7zfX2hJlGMbtFoAzfC1USLFvWc2XPh3rrkmUHL64U
2CzdwFPFJJsNbpHgwtvW/0KHfQTKngbiZ8NvmwckNZF4kAec3+6vxt/65OroIBpFJkI8jgW5qlx/
EkwmezqIQnSh64IAfYVryq8CXPrPYpzE77ncVW/9ZKT5mxz3BcolldiJNmy/GH2dtCYptdr2/zg7
jx27jW0NPxEB5jAld+hmt1rZtjQhFHyYUzHz6e9XuhM1N7EJeXBwDEtwbZJVq1b4g/MBBZzs84qM
buGXzqp8wwxwrIJqHbRPRuMtiZ9WbTv6qjEpZoCKjTacXDtZ6CoojbiMtalDCPa4WNup6WDjDZnz
EUOEwgoNuH/4TCUCu9pkTbqvjC+q4qnE5fAnTr8jlX/hNGcs4H5B1ZG5CVAASoCtL0X2IVva9qeS
pfUU1PAAAMijd4I2Uplkxjmv6qgjMi71t87Vas1Hvb5Fly0zyneUhkr9T+da9RMA0c74GK9zfi7N
bu2e2m7OfrRJYf2bxsn08+CD3IayV99jc0SaeHGX3GB3Tlb+TR9T57wIpw0qM18f/nglGNlA1mFx
MuDcxphhoXCayIPCxQT0Zo2YdlXT6JyqdLbe3V9K/ujNJpNzDWmOyXjI2ZYpVdciwKz0aTjWXv3U
r9Dm7VrUp/ur7EQy1D+phZh7IWC9vRAdQLD4DcxZSEt8+BstsvSl8qL0UmGdc5Bm3mqTApQkyQTZ
ApiAf9oEaLqz6PlacRZOitd+6yZ1/brALPxLRfvl49D009tJNOU3rR3T5iFVkwmTpckYmvNkutHX
+8+9Ezq4d3mzlPXoLmwnR4kFwnhsyU/AvokXt1/RIMKX5cLE1zlbdab/41mFffBJd4oY16UdQ9QA
oXqj9iC8QqnaWkvCFq2tM2QEyB0IIL/Eg+gDDEziz//hIeUgjjblDlcMYa5hjXnKMEtTekxSrfxj
rFUO/1ik0Rem//Pqm3ShjIMIubd3XeQrmYEAGrlB3BALkXZiZhsmlLupb1Tuigt14n64/3y3GDN2
FPWKxKVbOM9s7+EFO/Le0ZckFEkERRmA4PhJNQtEu/vIRPasiYt3ChzMH20VzY/d2BRIrXXYsZ6n
cmqDvlcz7dKuY3vwofdOleQmQmRgs9/MCWMdqoQYErJ/XctfJsWZrlPkes/5mh/N0nZetRTco1gk
D5Hdqdd3UZGMdlU3bRLqyah+dYRuXPoVFuT9N71zXDwEZuExECwwDNscXbyrW2/1zDhsdS6c2VhP
6RAFi5otQZRDuRqQVPrzyAScg2uWlh8t9m2oneYK1c0e79LKKoqTacfq1dYYyNuofBxE9Z1zCbYW
4Xk8F1hx21xATCxT1GJKw2bplKcxc4eXNc2UJSjI+vtLpdT6cHBCdjoMFIVSoFiifxgqv/5sDYhe
LdY4IapRiDctmffHznGXJ2RF1TBJk+HJsjtXYcKXKcP5/sfc2Z3y0DDPkkfnZj4/6qvtlKpNG7Ex
yqvppF/GVqnf6W377/2F9vYmrhJwU0CvAwXY7M0lB2U0yuNZozX8FrjQNxW4wUEZtbcIST9oZdSm
6CJu3iSmMpOx0ogItQ6TnRkF0eScGKY4ooHuHQEuAwmAAYV2s0kUS6vSpOdhhn782NKGvjK7di5m
X6QCIqPaBKmAW32wT/a+FbUqSDHmjrc4bLtCGgybPiKJYkbvRDOVgavhC2PXy5Fr869ouck4JP+d
Vh40LALrpmaHsWF0sd0UISTeObroQ9dmb5HJH/4nTAvlR+gjKLTNfWyeDPqNjs8Mo3/XoDYBeHZN
vmTZiJqkk0bNtw6o0A81joePVdGjuVhWVtP6k9c4R8n47ee3mMvIbAK5YmAZ+uuDxBEyu6VcirAx
XHyIhkg7ozXcHDQO9laRczNVdshu5zauN5DsOjEdsqlKTxm6KOelzZs/PphsY4OuDZ8aIvdNUBiS
Oen7FknG1S4ubPjiKoTWPOYCtsWfHk2GNdBJ5BCYoc12fNkKN9O7acpCRwFL3xRdcxZ1eaQudHtm
4E7RAeK4aDTbt9PAcumHMu6zLFR79F99vW/XPkAfw3kb9Uxmfb2ZNXEegZwcQTF+1WCvNzMTKdIC
OSeCJLmdBdsUUyhLpmUIPsiQiUinu8GoD2I+NdiCJH6mraY3UWShbn2lH2vbvqLO6rem0IfPFfKg
42nKBiiV3KY2w6axK3+0Za9hItXGaBomYALiZ69OE8CvwMT/pQ05v7XQT7UDSBHmW9NL0g+tZqOX
0uqeKH23Lo35tPZagedf37v2Ga1SA0h5EuvLle9VLUFarCi3W9HoFjCYO1PA0NbKPnCFlGYputJM
g7pRzb9Wo4YuPXoWISerFwpAsxAuYkIW//r+XrmNQbxKi7yd3hkyd9v5ArB48JSGzvVY9dm1wNf7
rNdNHtRO7h0E870NI7n28H/B6twI5DTRkkyKMafhjMCpD2LV/m7mApyvM4qPcFKwZ5u7P8bicgky
jyXG0oVDCXoTQsah14w2J00GOaI9dAuEF7X28IObdeUEnLM9OHu3jT/gKhR0NsUdmOabjk4nepSO
qizU3NoqTmmemD8yYUeaJAPmKMVyA12cxaumM4gX54cet8iU3/+mt/mHNNsg3cEwbU8JMktypYtG
8o8mq6JgjJb4E73o4qlbpvLZ7tX20dTFgKwMv/9g7b39RLnJmIPXfosoFwCxFn1i7aoovEDiH6WG
sokqbnHU8N2L29LpzKYOoRO/fdW50lLilOynCBHh8+xWzUPtlf1B3L7NH5HXJplC9YSOEMpOr++g
YjFWzq2dh7pSBnVRlteI/ruvtki7ALs4yMW1nfeH55AsWnmkWymMOCtyxarB0MT6oKMMsMT2Qwb6
7ZObVF10ltFgPllxB+/YHenm+KLNleexBFUk0rQIKgXfwgd7QjYsiCCqP2VqfCSW8gtWt4m/dJbl
BAsIKBfn5p3MMREPXTPushhngOsK/AUkDBMBbJl65MGfNaTn1HM7NMPbOJrNPgDnNdbndGiKTyr+
i//DB7hcn2w1rR8tXe2lrLUwcShOM+dsQ7HLTuqYuhAQC7WpHwv6X0qIT04xBq4r/aAihFjmcxnZ
XQ42Mxu7g228s7cAGqEI4sjSE/HC11/dppORLgOfQUMN5JNZmp5voCN9IND366LavkjGqzh1wnQA
Mbl5kauRNtzjAI08V8xLmOKhovm1zXzMR3GlEk8AOtHcHtLW0t5bTW0qgZEzvvA7S1LZdGB5JWpe
yxQFmaNWH6N4NRH1gJE++/Og9rR0O3NA9W50a1/H9qC8eAPgxCCLq0IE8by4b6hHgDAudqPiCTUn
oxXMo25/LYfV+GDVy2T4GvC41Fe7JM3OuT679ikeFKs7dQV0rrM2tLZ+mkZGu3RYnPmvWhilGYzT
Ej/UtTX1fplq6te2SaN/yyayXzR7wcHBARD7KZ0K4zv0efR6+8prvKeoQrjZb2h6RpclX8cvYk1K
xSeAo7JQxEo2ncsBMu2zE9MZ9OtpUsTJw0P5M9mVkl9WTMYel7xQf7pR5Uy+Yor+e9mOC2cX3GaM
DgqK6D5djVR7k5nt/JcmsFy/uJDfLXKCxTgqdXc6Y1QwwLN4ChrsNzfsYie4EKED/ii6GVlm+qSn
zBRxEKvl/Fb2CF+8LquZlvXVm1Lph1PP/CRwnEE/iGTmzr1ArvSrmALDdQu+j3WjzKfFfUSwxDDP
XjwmzanNula82GntDb5CPzl/yj1vyq5lT2aAur2Spw9dNgvL73tv8q5AtKLlYhgT+vOlg6xKjkCu
5Vu05d1nRibL8K+qibQPEEmi5V2yXT6rg9UVWL+uCXLxsYDbMyujWn9oBndsLnWfT9/LwsEaAM1z
rX7juqv3xl4X2zyJxBbvMkvJ/nEbnF0hYph5yV+bO355Xy5LoHTOlPkKSgJfELeznIc1McvpAyRy
DsiCEHoVjstQh1OXDngIE1DmU+Et2lvVWLGHczz21kHw2El0KCYklIdjTSIgr5TfhrRji1jOOtfe
o65iidvqZev5PTXVadL47kretaeEzPZg1b2NxrIIUsAlZ6C0HcdFtQToCsV9TJAj8DMbtMaUl/Up
bQamV0NdBG7ZRUHfkX6qejM9obIlrka3HEFqd/YZ1zHlB78FZu8NbgRN9YxRBz8EKtlpavP1RdHn
/szsyXrpB3VGxb50LpZ11PjduTx1qWWB+KMqZbA3UdsBJ+AZjdzgqlddoi5Tg6z1zIuUZrzez7F2
2pNcTMwI6XzwqW9aE3PFaNVE9//Rzef+PUI6ePxmLphrvzNWZr52ma/vs3REYt9pVSaXEMCG9NMw
KetXQ0csoUWMEXaTH6eRWv0xogycP1mLZERSOd80Z2YsViYpHeIqojjnabmGxjyVB6vs7XM5KSOm
QQq5wXXxB2W5QKrHyzBTGGYBlP205J6QN8bghfOQO9gvW0l6lPlpO1m2ZDIwW7dAu94g5kDiT07f
JspjHBXdfDZELEUSS88Cq8IfmSDy+waRYGtcvs9WOv9L/Ok/sG8Yplb5omHSmxi9d7a1yGofyC5z
/RQ5zfj3ArCM4Z2TKRd3FszrM2rQDwdbZ/fXy+qV9BoI9XYuQ/t40vQYPnqzEqnAjTLDtrKiAxSg
lebzYmBbAdkzvjS1pj7NUawLnzrYCuB/mS8T3ihBp4zKW8+YlcvqDurHeOmmB7Anyj+G2c3XpFCO
NHx20mAE8rjFqJWBnW6r/cFbnc5LgBgTR4rHbC2T69SY5b/ZPOef0lLRDl7SzlGGECOVl+iW3LYX
k7yFQ9KzHnSp4kcBo6QN6nEQ72Iu+iOmwe5iNMAdTK9RYNi2o3uU3DGqs5XHZR6yEy0nXFkwCnhA
es263P/4O4kl3HRCo0Rk3Uo31ui9IQrDczE4ngNtxUCgXizjoArd+1oS08yO5nH4bq9vIJ6QFCqp
qAkKoCZNuxZnk5bQNSb5OSW1foSp23uB3HZ0vaGg7fRPoZ4I7ECix7m0h5NFNnVWME33Uc/486Yp
kV2KfjF90bDe3jQyzShy5iKWj5Yu/TNMVBWpZReTr2JMD+Lb7lMBzKVdJ3lhN1CAfmKsOuTKo9mM
6ZtB8eZHupTd11JLHP/+tjhaavPBMJfRkjnOOF6IsFwc1aWVBnf4cxylfyxzTieda8Hmf0xHwTK8
3hsOmL8JWm/0mGHBk/jDYogAc5fpYXYIIvcfa+eGoA2C8oEsoJmXyUj4WyakiF7PwJDAL8+H+NyZ
a/aSlGN2cqz1azsk/5qdNh1czDtv8vcl3U0OMFWrlc/W6j1qdgodDDe7+WONVupIQtodQQb2no/2
ABiVX+jmbcrVSkiNivnDY+Pa1YuCI81T3nbmU2V3qM1O8cQluDoHfbS9J5ReCbLLQh9tC2DlX659
N0QunqpqHtrJQK+1XvVLbE31wbbciSN4X0ohLYZZ6NputuWCX6vW9aSU9aj0pxUZxtNk9BjlmWka
UJrb5/v7ZW89KcIqMWuoyG9nvrCBo2GsUHPIhzG7pP20/pw664vZ93qY2qN3UH/vvEkqMjo7jD1J
V7f88lRLK6UQEluSJGgQW1gYlBjtXJGSPDKf2F2Kb/Xr/rzlzc51Ck8RdkFI8J2ejcpaXujy2O8G
F27R/Ze4A+iy0D1DoAvlDUbo2/6/ZRe4nNmRVBv1tMu8lErQzJV5msFhXBXNWShEVoi0ENJehNH0
f5VTXgW61ihPcUyH+/7P2Xtyxrw2OAX20s3kyWhZv/Z0yFSonJ4XCG8P5HTKOaYze4BC2TmO6M2w
c+S1x/Wnvw43oxijyRnh8uF9tjw3XR0/aKmiXsQaF2fRWe9mpc4OwCbyCGxaOKAAuIcYz9MvdTZC
3WpXFgjZL8pj1lXx2Vuq/D2zB3GgT7z7En9bZfNkjVrWNgZEyuNoZyk1ODaWfua1qY8ONGCl+19s
r5IEjw/Xla8l3bs3V8QQFdLDkJYitA7nGybo1uOE9MRpjGAEkIp6xrsWh7anPpq9v7Q2N50gXQ2g
Y230x6x2qgsIFnI6QZlxU0sbguI9M0jNmkUtwt52itCLvSNXo93Xi6SdlKuBqr+tWBU1c+KsbOKw
M6w5dAtAM66V9C+eV/6H4RzvFAoAaZLkR2/e7QSCMGtbQLPunAC51L3qoRjLj/e/4O5BkCpvtB9o
xG+vCIQHPOFGQKEjbKD8xVmwo7JznAUzZG/HIu2CIU8OrLf23uGvwA1ch+tpqwsCGEmbHQRxQ3OJ
O/qBeo0ZLG8zjyAJ33+83aWkiATxjf/bFiM14bNArwy9aBh3wbLkmGt0avkYIdd2kK/Lz7E93oA4
EOWGMHIL5GZiJmq1pVZDkLW4DoOrIrEy5BdEU7NTOUzZFwow63Mfz/+hBQ0Y0Sb5BLki2Ruvg9k0
I5iDODRRPGm8a43E1slJh+Vg4LAXviiwaJeQTstZ2etVUOTXJsvlqAM0RvtDKOpjruv5wR2g7W1I
CkepPID1Eiy/18s4g8Z41UOiTBHWGvtIUrWgZvtx0XwbvyLxEDmr8S8DMQanYtXm5iS6ZRTXslgt
2beax8an8997J8dzgM/KvZH4dbGWP9VqFd2ZlqZ+NPrZ22ZSNJm6hk4KKezrH63razJDiFUeq1Fd
wtUVxQ+v0o2z7czafziwDlB9pnaIEN6gB9HFEpPaFDQ06tI9SdiUn9rqcG36arzk+VL5ZV1nB9yy
vY/yy8kPrTY68+5mh4Fk9BKhAi9TomlE61HD8hLjh3NuKe9td4GeAAXrPxxdSX63KU9p0m07U54O
b0bHozx0tNj8mNciDVDeFj8WZ/1yP0jsnFwPcCTJpMzQb3Z2ma1a02XA2pQKZSRGCKZ4MtJYe8EI
zcNO0orLj3ZvNusVKOlR4bNzrKhNCfB0Iun0bCOUk2F2hONrHFozYFtfEyoYTRRv1YPXubsOPTA6
YRJXsu1cmHVkJ21nwYoXeTP5ozU5lwmb9u9//i6l4yNYPZX8ahslkhLliNUcaWKijBQyXEbEagH8
yXw3CpGZ7wMvhhaIxcdRub/3gLQWyWc9cG03rRmd4ZbdRbRZxVCOHxhgtdBLxNGlvJfxUA+jV47g
jMMZ3ITBCB8UZ2mhqCaJlGBd07ZzT5ATpKZus6y0Maeqcc5l5pWRDxVlmuneJhMDktUYnMAQldEc
JLN7Ty6Js2AWQGfeNLNrd46trIZtX5rq8tLRfYABMB9l57tPToFHsSDBnzz/6yBnFQgiNpBTHmFD
aA8znekQj6z6FNtQOoxC0cF/lvELaJvZ95JhfFR7rz0Nk9sedFt2f4mctWOTAKTwhlY3WYMycmjd
x0JBueRUJkAW4IFbaXuq7MWxH5AcGhBtVFscpnUKlXODKIu4GEALXD9X7Ck7+Ek7F4AHeh6oiqxF
bxRILKCUYrHy6DFf0uIiQOU8G9msXSRY8D98bTBoUt0CwP6NDnC51hFiYin73FGTs9W32VmZ2yPC
0U59jVQi+smkEwgZbm+0eakio2vxobBzEFNJ28QPo6rlQH5EdGrW7Mf9sLH3/kC68ep0uvU3jDyP
YrouaunEa0PpVwVSEE014hgz5sWf32XSt0/CiiSZeNs5oD/RokUVK4iWpdG1M7pM8U1bNM9jt1oG
mWiiGX5uJetf9x9x5w4lzSYqkpqgrLTFVdaIp/cY4lIq4btwFYMiQtdZ4qcoc7G6QHIgnDvjKDEx
ZFG5yUo9CCQEBkI+5dbm5k4a6Oy4SpLfN0plntMGsaUgTdBeYf5RUY5B3BzCAQ9vw8+MRPwYhIs1
l9MCioN6GXHRq7mpnCCdOMtDDzUj9wdYz3XQCrEMZzcppvfL6ilgTUQOMlRLhznzsd7IvtFenJmm
l2uZXnrkjv7BijGPA/i94ovawzR513njiKscoKeHrBGuE4yEsPggpdy73glZKJIgXgniaBO3HCVp
0rZpaDkrSY2I/Ozkz+3SeJfWyeg8l0lXPyZe7jH/adLr/Y++F5qBzLvw8QnPN4qqhQVpvNJaRLt1
PT0PrdFfyzQ6Qg7sHVbPoBcClkouJbfeb83TumSmrk5cfUqbFQ+WKlRwqZg8R42FpUlt5Ad9xV9o
6u2u+n3Bza4SDba9EA1QOXVqm/56VwZSkPttPAMI5J8831wwQioAuPl6hK6XkzIpuf9qdx+aFiBR
in4jxevrh8ZJHN0UeGiEjKZ9OyueuKRrrAdKa1h+7NVHk9LbEAVfh2EC+aiLROCvSeNvL1lpu2xM
0IjBr2TETXg0UfqBhXC2o+KoCLoNFa+W0jePVmcAirxMyjS7TvV9Ldcp8FBPCpjdGS8dc2recXkk
DSQ77K+/KQ8lpZoZ2UnLis03bcmwmW7yTedM531GHvhHgCdnN42K0S/srn6fx3T/PKXDcKqw/9gE
VzKEQZBqHFHI4tvCL+8sd531IQkNo0zeJvNaPbtD26yPGWDW6GAH731MzglyB+jJ3kpfdWM36QrO
9WEex8WLEXU97inR/K6o++zgvt5biqoQhd5fZIttq3E248XMRAGY1faaU5+5mAohTXDuctSu7x+J
vaXof2FN5sIwu6GzqaJq1LiHCZsuqfK0aErxszPG/uQsxvzp/lK3p48eGL0GUjApdLftGxVDqSxc
O0CqqT2VjtvCMqb4kkdTfqJJsp7vL7eT8rGetFuTpmfkfvL3/Hb6RJctaTyhkYs0ovtpFFXkz2sE
+lgptfM4DAuoM9u44MCwnDC2yp8bbKuCOdeMgzbI7W1CqwWmAZ0QAOW4obz+IXYxJWMz8kOiqc/e
ebXlBYZNbYpMgROY82L5aauA9a5G68DAY6db/3ppedn89g4QNSqscVjysF1VtQOp0zW9dVatPH+z
umjy+Y1Y09Gn9QxhuNSEEQ6YCDThUETqpeNi7nl7rXEUOHZuA6xn0LhA7JAjfCNhMA8MsUbq81Cv
sImoqs6+9sqaXrJxptwri+bJGLvs1I+jy0cTyTWrJ/U/bH2ptogjHjXuTQ3fmRr2FOyRMO8tJ4gq
oX7RhqEPbNzMDr7D3tan1yOtkmnL3kBKRjVuaSFBnMqb9W+kEyo1cFGfOSld43ys6CQcBJDd90sC
Q7KKzLRxw6M0EhNtCktJwigbioueaHS40qU0/EGL7FNtRObZEsStWteSt1ZLzxbLIXHQP9h7ajIZ
ieElf6XGfr350KV3qy6GHae1mftVFb39dlzy6oKMRvdkksEdCYrtLsj7xZATfBCD9dcLOlqWRYVH
3NRctpZVqsWHRcnKJ2dSkvcFWtAHqdrepUuhg7wCig5E0E2EqZMhNxqMbcNyQJnCmSZcBasZY7pq
yBZK2zE6icw0PtwPbLtPCbpDYj5/tflfP2USk/lnIxpDwhvnL3OT9H6lJNnLZEUMa+P0qEu9d8sz
qvnFhYHKtL1l9VaUal+5Sei0Nm57E9IwWjl+WezIQoO/XDEKTPJgoVr2q2L5ef9h93Yyqk1IyMMk
IZ5ve3rWWNOm97CtjJhT4SYYa4haahrqQlelt9dLiU1WqAvduWAMML2hXWZ8qEas4w/KdRkpN7mO
Rj8WNh0iYIg9b7613QJfLuYhDgvm2X6BoMLHZlLUgyRjdxWqTGDbBodmi95yecNu4TIrWtLW+Eln
7nOLBOHfB+9050KiTscpizE/fcTtvjXoe7SDtMRRK2W1fNpEtBHTNe3fDGqDb/NChyBU3cT5h5Nb
5JgoIpLqVyPoUr8YwPn6ShKtwl88NqOPTegQB6uNxzjuD63Vn4ZqlF6SdZ4rR5e6vCu3n0G26gii
e0ZfBXm2l5Yapbhttl6gTMn6nM1J517TITXVh4wcpyb11Pt/4lIdrZPjzuqTFuXNt7gfome7Ltzy
RC5Q/7HdgLQ7J4tC4B1g2U0bc4J3UVSWAqhMiafL3PbGJQE7/1MvavX9XK1Hwnd7W4XMhYYiugiS
x/06DLBVHGVE1DnU4aGHlh4hNjTAmX13f7Ps8OHQ4ieBAqVEtXgzD0PfR0nogsVhWWSF60OKS74l
kW1+7la9ZSeUEeqFUJHib/rgaPMbZTHKBzSKxBissF27F2Opc+esl7Imgc45f0kcG4RA4+qK++BY
hSsQERqXf0D2O9/FmPXqVZs58SfbzVqEDtay/Fi7EQaiPjMdt3+YUBDzzvVQ4+9mQTt1/RWzieky
zUgyPCy9u6z+Ytb1E+g+L/anUcs/Vkuj22/UJBsa2rBDLK46WImvDv+R/H99Ah8daK2InXPXkCKd
4ce08ceDN7mzdcl/dbwXgc3dRDJHX/N6XXoYuepihKC37Zep66qH+6vs3EnMDQmYRCuaY9s4NXpp
DeGfuUuT1eqTaKb2ya7SLizWvHyBbfjZqyPtn/tr7hQRlEWEEnAhjBO3E+5+bDq9rNn66Co0wVya
5WPLDPgEYyQ9CAA7lx/QAUjGzNKRCN6GLi79rGhXQENLW/9oPHfkm+bLR8w9vLdR7FXDQZK4sx48
HXoG8gJk6C1D6W8J9BK5MaCSEohAZCwQJiVk4NIWCg2rWDHEHECvVLPP99/n3qIMJWTKRMF5MxvE
lbdol2GMHvtU0c7rpH93krXz7aVBirFZjywgdj4foyzeJUxRAuu2S986aQchifnEIOqJfDuW0Zu/
bZlBnRrZwRfciVuAOencck/+yg1fv9HYNJpYbSX+o25RhFAxwQMzaBxcpDuvEIlOcLCoiUgw9yYV
NExI143NeFWoDFEurU534qM9eQkQaE+s9bkRdWyf7n+3nRf5CyFErUm7FmzE60fDINbqUA9UHtvJ
bNE4XJVL3mSMByl2D97izlLMVYBCSC4EA5bN8xXdkiWIlAFYacf64lC+vhkbIymDtjgMXPrOJ5Np
LsWLFBO76X9D+bQVfTWK0EFnuTqPkQb90l5Va/QtaxS2n1JG/hCDk35Ny3IokYYZ5xxqVmH+m+dZ
+4aI26wnQ8BUPje5jqbzHCfuxVxc7S/4O64dJF6je5CtBnhBytR337VRV38abmxjkFJn00cX96wj
N/K95yLJ0uns09K5abWa80CHYFbysEk9gbj90pwirEMOIvLeKr96K3Q9sFrdHi+Tm8iaY2pwy1yL
h2ZC0sYzlqNe2N4qoBphgpGgkn7Ie+H3QBVrceoaYxGCBOyfU7hYQVf3R2aKR6tswuHQssykd0WY
WkAJjNlOLrrdqv9hc8twJHkHpDjb+wR4Psx1yCVhU6pKMBn0i5i/1RcTcOpBnJA/+HU+CVaAIIH4
7f+LWb1+baBG5q5bszzUojgVAdWEOEd26X4YNbuMT8ZkOReUfh8MJ08OivTbI0yWT9v0V+cSe5XN
EfbIC211NvNwrcwKI6dU9Q1zXMJEGZaD4mXvKUEtMsByJNB2iwtLEJurqLqL0Eggtl2TLuuGi3Bm
Nw6KCsL8D90Z0ScwSyMK+3mBcHs/MO6uz5wZkjOZJOS11285FfnEJJq33DdW9WSuU/xC/1T13c5K
Hspkzl6gsakXGGXdwcq7LxkRKzD9FA03PO5ed/oUnDgrr6q2BnjCu98tWJ6x7+rN0b69PR2oAHH8
MJRhyZs8qJqaYuhQ7g9TyNd4yi/JM8y84Xr/Zd5meDAGgCARt+Dz33iFZEY1MeetIEgjoVeh1jdb
5Qndga72x6gltrZJH72xabwcDY12WqqSrID+B2p1JJfbfSTUuBo6Iy/DGsmJz1Et5jdFkdnquUQd
7EfSW+P7vqucE4r6w1NuKHEe5FVRF77t4iL2Hz4tbTtY1GBobsnzMYjqDA2Ngt5m86lNSucxsRL9
pOZp8unP3zhgCYkSlXngVuYJlLHeD3ZShiDTC7SEPfX9AkXd94qm+yS8obo4oCAPhs47nQ8EdVB6
koMAZAO38aEbW3q3ZVyG1Vg3l8WO0ZTQrPndRKf5NDj6z6UdvGsuekQYi6460/M4mgXvbWi+NDuN
vomsWzbnVpki9AmcPBQ0yK9D6xpBBq73INzvPimoBKCkIFFuJ86K6caaGll5OHuieI+x6ej5qj57
mV9oTSJR5tPyXPdxcnbttKz9qrGnzyuOhUfg5NusUQJapW09gGv3JlpE+tSbA7Z2IR4q+eo3hjN9
b3Jon0hlzvG50vL/cpiZnhGUNaDQNzQgMaAdPJAXSAox1kwul+vT1DH0D/Ipslt/yNMxD4Q+Cuvg
+Ox9299Xln/+W8JA+xsfoy4rQrdW1hdzau0Qs2Jx0PneXYVqlxYFczrQz69XmWmQxmUb8Wk7z6pC
SIARuqZpPHin+2d099MBOkHUCfDfjYhvok5UGx5XXGTq7cUyfqI89R1jLz2oPKSa7y+2E4KJBsRB
erCyNNRfP9XQq3Ps5EYW5pOuZ5+Yk+R/6zhk6G9z24muGB/Uj6o6zA/3l915Rqh9jLSIC/CCty2f
3lxMptQWGu/dAAJ6XKkOgiijBZbqefekV8N40P257f0iVooQJIq1aAXeCLwD6xybVNBrtquJ7ro/
tZPePrtKr4CKdevxw6rqo3Fpq7RI/tehQNVfyinuzU9//uCAZaVQIe39m4+LgpKes3QaugCi30Bp
rU+NLkZgcnX8nDjDkQjUztyM5wZIj/40fPcbrtBIQGQ0gtKMawyYYiVRcxrTxXwW7tpfhWNjFZLk
SCwtehfgjSMCrG+fciXWvpDWjQeffW+3yXsXdJUEb21vXUTZB9OksRPWSU5HsxhMpbxYnbf8hRpX
ehoHs3v0Gi3+c6lB8M5AXMEvSKDVtvcRo9oW5SVTqziOypO5VsVJuBetBO6fjs9j770zMqc6uPZ2
AgZJKgY0sjdwO5AGKASCYfQYlakRci1N77x4a33EBdtJC1kF1T8poSBV8l4f4MTTS49CCYFTS0kD
yBnismpLdFpKPGrv7929pSDqyV0kscnbln4FoKV2VkSbvHWC/9T2ApenvPci1JtHHCPvr7YXIqAo
QbChwS8R7a8frFVgGXeJkoWlOuPMloJu6QEQPHhr+n0FV/XnUZf6jPYYYCS6A9scJc7W2kyFnoV6
V7aPjLndUzUZ3SMlYn7OIqs7yH33XiZNONmOpmK/QcRVCIcMusJ649QlYTJF67lHRedUIyd0vv8m
d5eSyEwm9juUk0KbFyVFFj1USpKSZq30cz532t89vksHb/F2z0Mo02VvHVVPotxmN3Zd7HlZM+ch
KvTkl1SeZ72HDnn/gXbSLJYxsZPhBtnpGQHBt9n4OssgKBxgK5tfZTlzbrzYhdZvuO+QC2uvDhKm
vqLN5sk2hTi4OW8vFPkbHBy+qOxR2dtklHPWIx20kFFa1sCGIYo/zKOyPGd872BqvNnyiee1j8sX
ejpLdsSFlv/91/U+64PaR42WHXvTHlf72EZR0CUf0TuR+bYtnnK3E+eY+V4wgPzxx2Zd3vdOnh6c
zN2PzMGkhYZXO/vx9cnstW5AVr3k7ZdJf16RSb92lWn88a791RhnWiqBJrA9Xq8CnLRK2xzhqjlR
oqDmbwWT0JxT3AnlILDtvUoNSUvmoWSuN+BuyaNXvL5hqaivHybH6S+9NTe+o64evKlZvYCinC5W
31lHHK0dgRQekzpbpyqD8bOtyLrW7DWFNkbYjpXzfq7N7Ec5WqB/5SRivNKaxIyjSJT0DZO3pn3w
eic9cxEMJ3vu0k/dmoA1Qczxj1s6/CzGLgCOSK1vcB6xMY6VYljkhbHdLiC3sujDigxkd1KEADR8
/0Dv7aj/4+w8luRUtjX8RETgzRQo07Ra6i0vTQhJ+wiXeM/T3w/diZoiiug96YkilAVkrlzmN7AK
gI+jwwDBcLOjpqgSFvbQaRAilq25aGLZH2u7a18v+cdTcVgBxK4kq+2eSiwG70tSplT9fTOcUyQc
P9mIAQ/oddjTY9nl1PaQk0WEAqEWHlQQqrJzZFEeQl8WyOatdL6lD6LqnDwNlmWps/dq3k1olGnR
EvnKqjT4JZ+qAfmmQknQExvTUZ19DSSb5qoKYm9uYutVjA9CWpSulIAM9CejtdurWJb2azepFZSM
vhrQb5xD81zl85RcZXnQQneZ9Vg7CIC31wpKbCvngnKIvbvtbRqo3OZlkaVBI6t5kGfT5He2Ia7d
oh3tj92AD3acY4KSDi2wTbBVQ0ep22FIgxgw1bty0DXUyVCpOs3osZ2SOpmebGNEzgmC2//sLgaR
p2CT9PpdioYREnRw9JgzbSJS2iV9ZBgIxoIz7N5OyyB5Vp5bB3Fv7yyQo+I9xxSevHHTTEWCOC46
G9hCntXDg2E10hWdMPuoQbD39VgD4Us+Hnocmze6DPZQIjHHdLVRTD+WE9NrOxibjoisA1b2bSZH
AwJkHDpfwNBvFLcI2iPElJEsZ6m6JwVBeCzaaVlOgzL4i2bP/v3vtLtbwEoyNaPPRRdn8wr7bEJr
cXVeEosm/0QNaB5OnVUM+qNQrELxG5rhtStQExSuU2Sl9Zz0hf1OzjooTPd/y95rRoN3bXOSEN1U
HvRsI8mekXCPIQn5tt6EQZw61jnFke7gsXeXooZnxss5uVFJ1EGRQAYF1luCFRx8Rcit8jSi8+Vh
1sLc9/6D7X1U6kpap3zQW5BIjBWKbEkZJVVnFN4EpOkxSsEeOEmo/wKEeQTv3f2o4ENgGlHvIEG9
uSPUCgV1Wm443YSjKlx0DcWj1ul6dUXXeMm8saR7gDpV9HEu4rQ+VWETXbOp0o76MzvvGTHltfmP
nplO/vUyMWl5K6OGXhctk2XycmXBQQa4VXodirE+uDJ21yK4Uh8wioXh8HItVfR8arxnAuDN6tV0
0ubkWPDpMgUSyv0PuhN3GPXSb2IVRujb9xuNjR5DI2b7lIt8yfO2OodyeMRH2bsDyXUwEqUbw1X4
5zP/1azT5gnaLgSKwESdVXcRoZx+4SOlfAfYZL/VlKLEmmMM1eKxL4eKyxCvwekH2uqpc0KdvfrU
ObPcn3Tk+q9l00WyP1bpmCmupszYoCo6KtVeSuXduJiZZCuAx7ZO+lwJ5/VHGwgMxTC1N7oo28wN
j3EmzKgVB5KpYcFb24or8ii7ZqYwDo72zmFjKUIn1w4Y1G2tkQ+JNqhjIoISPfEnReo722ugI31L
emk6a3o4KwfHe2/jwamBNERKDOZ73S1/faa4W1DryMm+caWYn/pWty+1FHWIJvbOQTmxk33j2gHo
lPwXTOb24aq5XAZofUyB7Ch5lgonfViazCwvvHz9CcqcFTDXrLGfhGd48A33Nj1FDHkMKCNy//XF
//WYaEkB3chZO0HH4zQDxjx1RtIdPOHey1yVsbjSCZfcty9XKbVBCbt1mubUObb3wJoMNNml9Le5
6OlBX2Fvq4AjBdtOzXRLukJTM0XWvhP4spnpKVHj6nGSoveVOpR+YdnjgTbQ3nLAKNbUHVIAO+bl
o42ID1UjcLqgKHPdb7ltPkc99GZJH7JLrhlHA6y9V0nLmBwMzSgG65u0xUgyq9H1XAQLOvR+po6h
z5Ys/EKTXj8ywheAdhCtQzj+NxgY6hW0VEBpBXI4hI9KNdSnNMqPBsq7D4TYA0MTQFI3KofAq/te
t2lzdXNkoSmcoHhUObq7oMn76X6Ev+2+8kBQcSBw03O/aRVmQwk6qhJZYDfdcpaIi8zAYvsd0Nn8
0rZt9iDqUH51F5RFkbMgXyZO3iB0CxB8dR1lBJKaVNmIlIG7rPr3/pPt7UJIKfQlybQYe61P/vcx
zrFIV6HMBhooXijojVs69XyO5qH2JaU4eI9Hq232oF4XLdcCqtdDmRhvKpH/SOsse+44el7Vztnp
/sPt7RDAbOTqtHnQVt8s56gzvIoiyoJ5gGfQAznwpBj2aVRyAu4vtftkgJKB6qEQe5NC4ru7IGLM
ZtQlyTknmiquaht1XpIm8qmJp+F8f7298Mu+h80OyviWdqepi2MVNo0XJ1PEmVS+CsJVSfn+Knsv
kNwJcQuu6dsZV6Vj3ev0JSJw9uCcDGi4p5lO5TXq1eY/fCsmDFSojFtIEjffyqZlLEaTcBilanIu
wyTWfGlaphOCz0N+sNje17KQ1GWwQ5fsptlaRovVRBqxUIplSIpKPHqJhZCzvDCvs8r2CIGyFz9A
3YBMhTQIgG79PX+dMlAnME8KrrHZyYtPTd61LgK6yTmpWvkT+jLLSU2kI9jqzqIkidwwVMJ8vW2W
xT7Mm2ztk/MC2qAUqCa7ojM7bza7yDOlHPPivmm/3t8yu6sSI1dlKC7urUqTZKlwTK0lDdoCa8OE
CvoiGBGdRRNbj8j0FOdlKZXX79NVsJPZpKGsvfpNhVMNzjJUacOic5u97Yslfp8qSebn6qQfgMV2
jgR1P80w+EXUFttPqVqx7gwhPoSTFSv2OTRF/S7KQE4+lCalzUFpsbNRiScr9gNW5Kqi8XLjTLh3
CC0OqcczYX2v4zq8DH3dXoxklFqXWet4cOnsfT6GEJRoq7z2DeyYl7gUw4ClI7Q4yUsSvENUPY6u
WqwO5wJ4vKfLWF/f3zPr2d405NdyYB3r/kmINp9Pre1+MLFlD+pCqZ4tZXpLGWueEwsfTiuuk8sc
FdNlwpzr4/2F9z4ma1IeIH1325dSiqbPAJ7QiEPYK/Xw50H6Nx9hMQ2mGf6Hb7mC1mn7E7dv2lOz
SsqAOnwSaGYZdx66+FXrVVoV0wwroVQ92wUX/cG9tHNPcAFyr6PYDlphm/XhMZuvGS90uHXWYjqF
eLLx3Dr4gHuroCNGgUXGRwzffMDUrKFFdfS869yo/Gxe243VUBxE7R3oGeeNkZ8F8YfCavswaSTG
CulsgHwKSYQ3UPd9depKem44hqmXoVpRuG1RF5WrwATyo0g3Yn9JAJrIltYddBj2f84KTl1J06v1
2cvDCTmhzEEwkl5oYD2iocy9Ar+MN8pSmF9wBa++FuiU4xUl5VfB3M3vs7p7iiZUI+9v4/1fQmd1
VXPboYzFziQ4uQoFtciMxpsnPXljpFLCljaFE7Rh1L1tlEY/z6Uxv0O5WX6KGzzkcc3pXs9zBaQh
O2wH5s9oHm3eClbA5lKU9HqbLP4l0JyhaktbF9FV9TKmUv0fth5ZF5GfsH+LE45ECwTFMEkplXR5
b1h19i4GqnBwdncChUbmr+DqsIrlbRvYiG+Yc4RuegD4bDy1mv1rbuPuTKpcHdwvO7EQxj9BgmO0
8rbXo/Z3qjCE9mQVMmT8pqx+6HGZTg+53Yq3MuyFym3jvADzUmN00duTKV3u76S91Wn8Iu+KVhOA
9U2iEi121QraFYFE75UBMHCbtG7Ls9JM8TWrdfPS4DtwUglkB99x7w3ThmSmTyDmbl1/2V/P3UeR
Ms8ip9UtZ/MptSTbj60wu9CpKg/iyM78GfAA8Aio+ITE7Q5FyYUo3I5RkC1tF8hy12Adkude3kbT
RwsNf7fAHu1ixXhDugxZX88SpABfLwFuHALzdtSPbcSIWTefeB6yEwyV5bx0Czybrk18vuzBi925
0YmY/EyoB7R5t2gQPM5LNBib8KFIHdSYJGN4Y1vx7DVyM/sZc9tTPMrRx/v7aIcxuDIg0XQGPUBZ
uW1WtmTeZSS4EWRcQ6bTEllMhc3FzPPTUpe4ugygxVCv1rJSgTc8mu9To4uh4BtmOHiTVSlfFCXC
tsC2x9/yGIvaVzOsGLymzqU3WRVGAp61ikBtg9uVdRmWKfonUaZOx0Goqx7DMltkF1mOKD13TVt+
1ZtSmS/UUplwGcJ3PxgX1fGZYVfzGUvaROejo5jqz8JJ7GthmHPi50pUPhfQA3u/RxpS/KI9TnGH
lsNyWrpej65TXUbKF1Xt5o/4zbZHSImd44hiLNQUxru8zO3UNUMyEYJjEgeGCOtLjlPDeejRwRNS
lf4vrRjIzGERQ8ZJ5Ov9D7iza6Aj0MBBsY7Mczs2jEOlboqRIZdaxWWAjyTszSnu/6HrgT7GEDUI
omZH2Pmdg0n+Do8eWxHQztvcuhZY5vQO7Mi8j6qTswjZz5DL/lKrmkClR1SXKSoGr7XAnw1T2X+7
/8w7WQzdgtWkEBjTCp54GYJKa0gzaKEkaAiRP7SJlZxlsTQHSiB7q9BpAcRHHoNTwybAVzmeWM6c
rSO2oYxcfHsHvxTFdNBe3F+GccTajoBxuk3J2oXrIQa9aIxLkbv5HOU/irg8crbYKVDQNiJgE9D+
ZJgv31m06tSw87F3jB3jqbLxI0paTXVbBBP8clyO5tm7j0Uyi34MpB02ycv1tBF3KKcgiS46qQpS
uxMfJjEczVr2V3GYgzrcxfx5uQrC/kYfcdXT70Pl349m2fCiTCTq69MK/I2BdXLfkYVv0RtWCo0d
JBLiRaPeRe6glNRbpdVCWx4lQO6v39+sRLcIWpUMOOXlU8WloqZ5DWZOFFieNRWI7Lg5FBrci1mw
bGABk5aBStmsYnZ9X9UgkAI90qS3HCfLTxF3e7PYWYuy5WT5RJTCU5Tp9SLbf6yp4N2oKHHctJAW
yYErlgEbVRYGmHMpY0O3SP0/sAa/3n+TO8kKE/IVFQwng1HmZheOsa1NTZ4nQWRWw7fSKGqeLGk/
TgClDz7a3gFblfahAjNUunEyT51Bs5MOD2f8PplDNE7QqUJ4ZrF87uLuy/3n2l2Mb0Y/eN3221wB
wr0taZmOuXcfdU+OkcRu3sv2ucKN+zTxLg5mZTvnbH0sxAVo4dPk3uyVZNFVMWolEjV5Op9JJOaH
BS6pf/+pdr4Wq5DPkrtBt9umlkknxmlWJsy31WR5N7W44ZhMA9/07XiE4tzZ/CYYm9VNnANwk2yZ
Mt5BGKDEAYMWRw9SOROpby59cy1tyTHwEzTTS8Mm/ezUi3kQ8veeE+gopA1mStSlm/ur0Ep8Y/AZ
CqZRNJkfjrnyIUzHtPLlWJ3P91/qXs0JngBkClNOmprbMyCJKCzM2iwCgYbhSZm10M/kSbip1Unn
wVLDa6I4HykU8Tw2CgdSshL7dp8dHMWdLbu6seH/wPXDqHD997/qBrTm67BJhzwQahk9FCjheBNY
9bOROyRpQ3qUo+x84ZVEuAa4FWO0fWxVLiW9TqwiGLVJbpAWSeKv8iSprW8p4Uzmkpjv2ixO/BlC
4r/33/nOcQHkB3QErArjte11Udsjl3mo50GbA/HjA4fGcyRb3ZGG0k7yBziNvA/gP8YlWw67mi+d
IcHSDMQ4RCgTD1BjuY9PRQvIr0bS22ubNr/+h4ej4wjmB6HTm8I3Siv00BqlCPRQbh9zvckfmjGt
D8rrvUejJoEFSxsOvM/6ef/aLuBQ9SqT5iJgMmT8aodFvYaKlX1zqlKDTRMh5YT2cHaEWd/7cutI
mcaIAfh4q4sLTAX4YhgXdMWz/pQ1VoLopjoewMV2AgCTHmgGTISQcNj2x0Ia31CPRBnIWlXKrtQO
ZGKjBUrWRSTm0NVs5yjQkebo0ZxWcF7ZRO+6I0UbpJCjEJpOf7WtsX1i3DJ8bR0lLnxLAzvpYazb
KwAw56k0Lvd3zB4CmB8AE4rZJRXDtkjRQyVj29iMcZYJdsrS65nsAhRrfrSxk+LEVxvVch2IG7Fr
ZVH+r4ZN/Wc8SKefdafaKc3lLlJcCbJ1eHBt73wKrmzOkALKawdzhWE8IoImPy1CTFWO7PlsaUK/
UvrIB69hJwKSgzAC/xOWbhhhEhh+kyaYIJmrK99YyuEN7og93mir1zqc64MotPvaCbVEIbAftxbk
kiEi6MVAP3on7N62qWk8k/zX9hmL1dk+J5MsLRgITpnst2g+m4EmzOYDcqvIuFu9lMoPS55pV0D4
6Fne3xJ7r51yZ+0HwkvDUfvl8ZaqeCyViR1Rpkb+S0pmyO0SGh/haOivx3nzxtcbYPURvOn+Sqot
JhIOBAq05LcR6s4bu+mHs0b34dPrH4rhFjwUepCE5M0VN0EZChPVEEE2Z6U/y0lCeYXCXK7O1kFB
8qfG3YxiGJWvaFOq8NscGptNY46TOg86Eabfx6JZ/ulGsYTumDnZgzI6+sWkBWO6epojvmOXxmns
6N+8+vg4BBZmbDYV8i1YJVUKyUlLLQ9qTRl1D2phn/mA3VZU26w2Rzqht9vGoVtPCrHWeyvb7+W2
KbN+sOUYeLm1xs0ym8Xn2TR/oPSqvfqWYyVGlCSkMGFvuuMD13oRoj4fqFhouYYcLg91KY4AOLe3
HKsgxISsJRa5N4GRPvmoDXbCZAIB3k/sE/lKFpf90gDcWa4cm/1pkBGZP/hqt5EIPBi2TgQ+gH03
TaOMSzut0wlVwsUUH5ACVqE0l+1bc9br6DJoiaKe7x+N23uVFalmacpDDLjBK1tlQ4Vm6EkwJhH2
2mOX+1JlKQcRdu91siugWaxAiJu8SysJdi3z+qCtRXRtylI5zXlvv00wVztTC3QfVj3P1x9F5vYo
5f6p/PizSVXihEpFWShnk7RQ3Szk6C1OH3t0CucPDdK2v0fGpQ9K34gzKoSRW0EaLw4+6d4LJsqB
RFrHOWSFL09GZesj74RpDq30/BLGTvhI9nLUB7lt/DE1hBhJq8oEorwN2wA8ZgXvhzSoJGnuL3Oi
O1eJy/tjpCLmd1a7QZYhwMfiPQjcpPcYpTbPr99JQAxptarsJOLOywdFty/qcjWGPBAO0YOmSYo/
opZ70PzbOyEcTUCbNLAM8qOXq/S85L7DoSZQ7Wjx5nzqn7NGRRA9in6mArTL/Yfai2sEc5MmFsjh
G4hcgYwL1jzwB2SF4CY1moYtTWw/dOiOHWyUvTOCjaOyQuTWemyzUYZc1dh+FtjuWFR+7xhgzBEj
hWJimfEqs9xF16WY+8/3n3CHpU1bBPbuSlLm2t8Wvf0sVaNcUnFHRj2Fng3SxpumUH4TgXn9beRt
03mQ5pWLEWWz41Is6uGpXhb7HaZbEvOdIrJ/3f9Ne2dm/bgrBZeseFuS5kgg2s08xEE7JtrPLLKL
Z334D46u6zVNGwqMJRjqbTEo2RJUjYbZgG10YWCN6LA46jA/mY18pJn/ZyL2Mivgw6KBRwBkXnUD
6KQYRnPKIbCnWSJwc0XO4U2dj/nsLlrdAtLIInzSIgtdr3PKFfoRO8E8+tlEZQx9RG2/DGbVv5O7
Lm/8zqwH7WJbbHl6dN1iuktc6oqLhqPGEGYCFnu2O8c4YZlTtRepl6tT1dq6oJ9QJ187zRlnT2sH
BgHKtADfcpSktLwFwK7mTgpFz0H03/mcq2YXDVOkqG6VUlGdJteTgFBMpfNR6YX5JFBmP6hLd04q
i7CHMfogFm4jYKQJtcs6LQlgF3U+huEMBdSlfjSGUT64M3diEOhcQCHrp7ytmtQ4q+Z6Bb3oo6wg
Kr+M78ZOjZ+sZVF/FPI0HESG3fXWYSf7dEfJa7AKNPMt7mhJoJKYJOZXhDjFdaB9+Q4JX/vg3tz7
XAhzUBdSS93SJKTKGZDHiBGqa+SeAZ0ynaCodwer7H0vngcxYlptt13uOlqUtoR6GUyzSB+V3qz8
UlIVD25YdVDVr5Fzc/hWzXASgFU7nBvq5Z1RIsiIDQkIh7gx5l8ZYpNezwD/OvWi9yrJTt9YWEU9
d+mha9XOQyKbSD21juXp56svV1Y6hemihjqZQx/IOCPsmb1N8rT5JlKp+34/aO7sElBK9BGgfPFK
tzJDZqPNaCuvfAJ5Ts74OJSd1+sMjYuslRq3KXT1oIDb2Sg481JVMXiBYbcNoJmmLcWUVHmwxFLp
mUOhXVbTmdP959p7h/AJaE+srecbiyJTMiAlLkkeNK1OizuKkwCnXtMDlXak1bG3FDkUOG7yC5rl
m42C8FXv4DSaBwhxLT+wFIxCj4mc+TWBpPfv/cfaue5RhAF1YzAu5cLfrDUQnPXUwDG1VEfxpEzj
3Hhh3qofklBNCndSlRK51FIcxOL9Zemi4RWnMORZv+lf7bt+pSdXM0Daxp6K3u0JK5U7xMI4xZMu
GV6DbFkwy6Nz5Le3924ZwwD7BEhOlrp53plT8v88onHqTT/BYPBjoWF9mk+y+v7+q91bau260lhf
6YjbTErKDHXKcouroCsMJGdQmHetShenfNTAO9xfbC+4cN8AwwV8cys7MeKRPOcmhhzyaJhfWjEp
CNxqrfVgisZ4SJdKuyrQh57SItWPWMF7D0qPGX4WL1W3VO3lx9SBzs56R1Zh2PBeylpfTnKd1Ock
saODs74XXf5earNvRD+KqJoUxsZ2np6L1G7PI7fH70VLMB2q4/D1s1Yg0NgK/mn+reyKl8+mSW1d
JQU2BL0y/k70IXwj2uQIrcU9w3+zuRvWi47tQmuIXtwmQqOEkjBnADUVVrGhf8wpb5bShS4vQczt
VfkslqS13DBUs85DTcfovaF3lCCqQ5HivVIUuWcpvTRfzNo2K2+ODPkfbG60L1abR5YLtSZtMBTI
J8OXddGaz/OSNb8zOEqpa9uN8zHKjKK4OiZ6ExfNrpXo1MZF2boSCt2BUBRs3Z08C2UvLqbxtykX
NhYspS1/VczCUf0ImOQ/wzCG77PBXNrTmKtF5ZvqhIK7k0bDG2ly2u5cO6n21S6kafD1rI9qrxDa
kvuCOY3jt0Y99C4uupKE0+iyvJ1UrTIfqrEH7D5KYO49B57rL6OlsHwf0mkjZoRmplzUqmnhP84L
fdoBzTlvTspMeF0oWZM7Gx0z+QXcIqaIc160b2EcYTVcC1tUZBfl9DNHcRCJa3pLQFOKaPo8RVP2
iShlLe9ax2Iw5QL2F8a/qE1OaEG0SvytTetkfMgr3bnkA6SRB0kd2+hENq+knpbJtjiFssjMk5xH
OjYSeqRqxLVEk7xSS5O3C4AB4WP21P6P6DGZj6qYEvUUSVIDMGpMi+FTOlPk+Iut58XzUtbthyqt
zSf09aLcXcxxap5ns4orVzTm8tU2MufXaC7z2ZkwsXL7BKWfq6SYjXUp5DpH4nAchrd9VqjZ09iO
w+hCQI1sn7pyJL3PjSzyl3yAPJo5o75cZczxIjeSufVO6PRbwlfmXm+8ajSxNqzoTbXXTB6U3I1E
Vet+0znJYzGPbY/zd+Z8RYRstL1uKoxPtWO0hWuB1rGfVGkcA6NSRoG0MKRfT+aima5DXM41ug92
rif4m7S54nYO1CmYPtXY+QKAVP2gZLGJ+RaXRe3aQ9T9W+vo/LmhkMwavzpGzl6Ljbz8WHWL8bmX
whgEmJEWnugLVBXNjCG1OwNzi54HisnWzW2zlj4XU6OaXgS/OpCqdvmgpajcPxf47C4uOVs6sCmd
eXiYkrr5NMyt0bl61WlfqlpdlDNKq2b5G09KNfdU3DSOGkg3sWFFF2E5BBqX8cDNNAjbulnHsi8P
4rApPHyFeZXtMmq+qJwfQ2RpJ9uehBeGxRGJ4CbasjKXJQjLFUaFVN3L4FcqSTxGdZ9zE4fTSdKK
/CSqargYmbW8URNjPioxbm6SdUGSnpXCxsW5Hcoiv1mHdcyCBc6eQTnLE8jC6j2wbPH6Og0YHhIo
tMT4u4XnTunULmKskYuunfKfKZ5mjBnDkWKtyc73r+abh2KmRbrBxcwow76B66RDUUSODP8vHKFp
5kW0wEqojLMqhUfuVOtttL1GyOHYIwjX3FITkngB42gXjHnrsf53Nen6pfTMx17/QKskLvfiKhW0
7SVGCZJuYPipmbSBw9osU+p4tp0aP1bV2OX1mQ1KkAACSG3oo25vYL2rtNkpKJsyCPpvnEQbLwNz
4eliahPJau0k04M+FMqplJXp6OztfTsMr2mGMWQGe7I5AUUN5o7GUBoYLY6Reac3squy7kMhdd3r
RXDBzgAHQI4XxNoNiqYwE7mLF7qnqgLVP1MJTHY3XVo8SA7e6U76TauJkQLoAEqZbbOtyqYIFjHk
LqPPtWfA/eFHp3bsXzntvg91q/zbTNV8sObNq1xJXcjKkXNTP924L7SZPVo1rCQsuubEa1f8bpVI
6WmWjJ/39+dNF5ooggI8XS4OHmttcvyJSaFsjFYemK0qvtmTk/8TaZ0JjtFJu68Vmr+XPmtLLvN5
+gwHIK1O93/AHzzvi3O4hmzyDzYsbsA3xaJqSmaJ0C0wgVSko792oR/nxml/Lnph/8+MdZIAObcz
1c2bpnjKzCa2n2a90iS/iyVbnMNJJN/ksJCZg490C+7/vj94rO3vg0ZLYcIgkpbgeuX8VX5hezMD
0bWYRKpLOLjqGAHZntTRiHxd6xruxbC2S5eMZaVV1kWNpu2cNt/VLC3/kXFx+qgaiT77ywwl/jr0
qGW7RWK08VVzautT3rbmiBNElX0HLiC+CTUEvDRPxPbToJbKchprbflVTBJqn9UQat8aFFcVgXde
06if2f1956btMg3/NDGdupPVwiplygbF3iXtMWmqAdP7VkeRMbmUA1biYTGaOi77dujcqMT+5S0B
LPvQoAMVuspsj18O3uE21PKJIQ7Ss0YCD4Kk+vIVFkVsTnGBrn3Cs57MJew+GYmUvRZYt65CF4xx
JhScm5AgWyn2V7LIA1l0KhEvkZ6avD6StbzFgLEM8ykiGUXI7XQoSVNhCkClwWKFyUWIcDyR78j+
lKQ9318JvVio+rs46RJs5ozle9xY2jvEuY5objeBaf0hjAHJ/GARQoN6+VbNMZTpZDH3TzJ9PuFG
RNiXWmbTsjb5mS2xJwmTB7nAXoLFchwFHQPSG24daYazrMATeiBR8b/IyIeHVIpsy6W+tM6hXurf
IYilTyGq3EeMu52oCC2bTgTNR7RZtyeRrVVxyKoiMPt5fGxkMQA4C/FGG5wj/d/dpVA5pqXKajfy
NqlUUe6t2CXUqG0anFIEVQW1gClb7IOUZ+cz2jIDVmRZacrR73/5GakiIm1GsCeYW6e8zHpWBVVm
mSeFUYNX1XH5KFthcbDozvPRUEIeBuAkE6RtWtJotUlmvuQBWtvddw1LykvS9F3vJupiHUHrlHUn
bkIo/TK0gmiH77he0jijghjYNA1lo9sMhvJgNk3ulq1AnTCZZRe8fnpqst7+PTIq9KsE0F1myu01
hUVzkYrFeKAL1q1ylYsb1vKRnNHONci4l24QSk0yYMNN7rJKBynTRDKdGBbwKRQec4IlKnVnvB3K
j7gBtV8XAMTnKUMkCrkNMV/vx8jdd7SOSTmy68RpEyNrG7hLQ6kdLGpmPsq98YxDBdKcYw5VCouT
gwxjbznmOjSDGVveahtWZl0sTJzyoLIV6ZNdtigPGDnSo9UgTos1d9PBgrcoG9qQ8FtwmwSjdDu0
bIeqcETeAVoNzeotOKLolHdVjPCSkaXfMCcaz6LuKsvTCmf+GHbp8ADZqTy4zvc2Pi13OPqkPLcG
oeokiSbXAdnkZps85tCfEO4dareT8sR//RdlsMWMfy0yAI+9PNi5kJfazsY8sIXZnawocS4Ipoir
U0XWY7c01rf76+09Gr19HWAciBSe8eV6ajxV42j2EGKjuP3OSsbiIb2sfzKGodEPPufe/mH7cOiY
OCG4ujkwPW7TER5WGWJL2GtnSrZclFqtLyXKJF5vTfF/eDhSYiwxaWmya9eH/ysLE0qRWeGCVULF
SbksYfF+cKbplOCJ+vn1r/HvldYn/2slUCVKtJAOBR1DZh9YWEbfi74bBrJHDdO9L0bqizfSyog0
tmdebbGBcRSKw7mtSrcEx/ck2g5bKehvn/7DU62YUbqhENy2ycIM8RU3XtBRqVx0QWJx2P3SJr6N
+LBJB0XvutO28Z4ujMbU4I/g2eYVZrTKZLpEadDHUe+NtjY/xpW9HKQie29vVdYkNTd2SsCxNRO9
Aw6LUPWifUqXODtNnbGcq6U9qsf2HojuDr0W2krrbPDlnhiEQ/FXM6hrI4EsUWzVAeCdIwTbTm7F
RiB55Rpg2r0dguDAbaZTjd0YjE2EUeU2dnV7bh+MwYxPsU17NqmH9kJCeBSq9l4lGTocDnCAt4Ty
3BSgCrjU0OVKEwgb8nylZMw8MWXl+f5G3H2V3HCgRBjY3nAXWnPCZSo2RUB6Dd157hDVHKwjcOPu
bUM2BeWL6pL54OY6RWA7nlprLTlCpz+lbbrQKJXjD7O2pGeSSyYBCCR1Jy1bKKvHvsWx2CoPyCm3
qGHuvJWWAn+Bi+8mYw17BD0pfgRm4p0anVI1NCd66al+HlK0CACV2Dm0YAmmvVsWTtNfyjJH0jjL
sGyl1ZjnLlCC/oGc+6j9tbfZiDn8Mront2DtZojSIlQZAhTApR9Hs2aIYVrSc56UP8dwkn84qLV9
Hxg5HNwcexuA0EDxQJ12y+9VQ9uUNKcSwSQP5pPVjckXtEqOtKn2smpuecA7ENZw8th8f9wo1CKr
8jywEiv6lfdT9NWRutlVJljuQIgm15myI3v3vWPEI62iPCsgdBtkOx0PHbtDz8nIDfkpV+a8ckPH
6nQXSJb68/5B2vuAqwQc1iA2zaktQtpsWnuRcxbjx8Cp1ZKxuiAYEZIfN7F+QRQofjvV8ujTSmoP
Su01gG8C/IpVpr6E5U67e5Wu/uuOjCsRocpJPGSgpL+vFenfbBLOb7y4YmrgfmgORpk7e+bFepuv
2cShOjjrCLwTyiDcQu3mn86ipv79V7q7DGRoiCSkNDc5OOEffmOsZRD4S+lJqiEsM8Q9yGT2QhMK
DCuVEuiHfiOWzteUmVviYzbE6jBcURqilYRfu+mbiTAVXzLNRHGNojdVN266pnCx2UmEn2M49upx
NIpV6LcC8KX85KBsbmrZyhqCHzljXebfNSPDRtjuTQ/Uafn62xpvEzwQiMnYgmyHCHKoN1raoTTZ
93n5uSttulZFCT1QzOZ/yAzWj4ii5TqyuAHwDgz3tV7QiLMRmvhQWZnxLk6r0LemwToo2/baQWtT
kFBDU4KTv0kN8AEpJLNFVs1o9R7uyaz2v/OsKn82cl29mVIlPCuirWHxY6J2gkM5PKha0SsuZnba
wf7diT/sKOx6QZ4hQ+E4L4/l3DaVLSkkyaoZR1/6ZlY8YyybQIhoPt0/KveXAij1cqkSn+NhcYBJ
xXOYeGXf1z6qVflbSaNwvr/UTiiHN4CUIX0YZ8XfvFyq1XADbteEPM4UMEsW/IQpTpMHZ+qyS400
+nWOj7ATt5EA5BJwQfYrBRw3+Ms1JzWpu7RomCNOIRZsYWR8pG6Uj0SBb+Moy7AZaQCtefm2ZNPi
yDIWh17iMNjzKYkS7akdpcIPpcJ8k7TtkZLA3noq2oZwgtm0dGRfPpaa1aW2KLR9krhS3LZSwid1
jLO3qjaY/8fZme7GjSTt+ooIcF/+kqwqVUmybHn3H8LudnNfkjt59d9DH+DAIgkRmplBYzADOyuZ
mZGREe8CfgnnnNeXbu8zQvkEqEEHZakBvxyvMEenbQRE1SborY+dpKTvWlkRB6Ns9yIuUThP0JzU
yGjWz6hY5y1voopwG0j9/0E0NzinXTQ+anJ6oBS3vXMZiQfoQt/mdbN+B6Q6na0pAj4HpaT6Z3aw
TfKsVjYudjDSFEC49GoYNEpiG8fIg2Ow9y0Zc6F+8OLBmOLltwTHAd1YA1RX4qt0bcZReYjH6ghJ
urdD/hpFXa2YHkRRPqkFO9Jo5fehOqXnKpqms6l03yWAz5fXN8jecBgsLu4FZIQbBGTSkZhDk0fr
eKparxgkK3FxsAjvY7NrLg1/5kDAbG8F6ZCS8SrAzTa9bLPRlGCAlXirFTG6ZmQBsUFEAa2/Mfgo
gd2mKNkn33F2d47i2B/Pv5dZEzUncFHsn+XRv3nfgefveFDltyGZWrAhFhmU22IHrng9/ZFPlUgV
oqgMEkULuls6dtIDqH2crHCD/Eo+Z/5EYzWtXXvMkxylqqA/2N9bZgGsXNqqnFhSysWD4OUms9XU
GGg2QPADC/IcpmV6Huo++ISIUf+AafR8B8QLF+sMTxGR27KLaLPmhX1jP2alFR0c7D97ev3FAPTw
i3gUE41XP8eQQUPFbQ/bFkZ/4XZmHtRekmr6bcgHu3a7yChiH/fDfDpLQ1mVvj0iAerGipbZHrAm
PXftoDZtDzAv1tOh0kbx+ySpG8tr+wRDMiufwV7FkU2Ff2xrVT6YwnIq1zPgTiYHISQAG10OwN+Z
srCjMnbM/Obw9jvpFJHOHRJDcELt+lENkPdxMpTipmooEGGtj8Rsd86XgcMmAv0LQHbzIsGF18Ew
XS1udl9LT4Pct2fFyIxLXU6OR03oSO9xJ7nlMGvIL/IwoZK+jpAcLqkIQxxeROLI1wmjPk8Y2ld9
dErhGdM845NUlWARYGv374Qw8i/woMa3fnUQupyyRaUHCYzNvVoWJkbxdDOvWMl+E7Wev4f/bi5t
V+Ourur8SZtrUGDynC14LOP6elDbJCz0pxaKMJTcRSR+3VxhYiZeIaN5dSS4ICW4sSd6R/0jrYfx
nKt4nFI8PSJf/4keL3YaitkLgJYLyoKKaKzeZKPtzHYiJ87V0dEdfNBUE5JKM6R6eq8bo/MFvWkb
laesi12ztsX7vqtk08W2Pon8FF2vJ2p5snQXOBOdwzlIw48Fm/edbCKMOuvNfE/2oB69Pzb7kx+N
KgFtPSq7qG4t4fqv40GhehyzUrKvvYi+JjjMXXQrTM8NXH+vbXRxkLXuDEdebEI4Bfy+5fTgCtgE
i2PqFbnG8TmwmsajQ4wB+BRKv2xRf3rrRoCMCjKLotqi3LneCLYVyr2OAey11AqNhlYadA9ar36T
skB/n6NaeQcStD24UjfZEJYcGM9i+krlVqdm+fKTjnklet5GzhXY0XS1dWF7+oS84DCgbvj6/DYp
CUNRpoNlRzMRyNEquPVdOYZBM7LlTIT8fBt5ufBOBwD37+vjbJcNqgI0oYUMwgddS8L1BqeJWpV1
FUNm+4meSVerA+gTzHF8biuhHGyTTdBGoIplQ1GJnjLl1NWubNXBFrna2FejC+sPTlq2dwJAxV1o
VOVNGZ3elayyfGePiJ1PWn5UPt/GD3Q6eOwgRkddmx/ycgWFnjny3CrWNdfk4Alph+w7bcuOUY3C
+IGyIZeyY4nQf/0rbzcOw6LHxWVBgrRJ1ru6RTYejsU1sqT5koIv9tAXdc6IiScHG2dnQSFokoRR
PKL1sd44YR4iO6j1Esde/gxAW70OsWyd8eMu/L4asy+vz2xnuMX9A70e4OKc/FUagVxhXi7C6NfE
rIfche7VfB/sNH43ljlK/MP0ZjAo6AiYcywibf2lo/tyBacGAh2VAOdqD4X9URKV7CaIPn4Ddk53
R6n/e31+OxtmUZxcnv6ENfbNy+E6DP94qyrONVhedANc23dT2ilPmmQJt3aU7jrLWnd+fdBNJr3M
EaEClCcWtvY6VYSGAjxlrp1rm+tOeAmxOqtcJ19gHzMoo/SKiqP0w8gK5WeZ1+2RVfE29jA88IxF
1m0JQ6s1RYy1G0yTUF4z6fNka+ldwCQPqlZ7o/C3o8/KPc5hXHbWX/eTnWhaF7S2cxW10L8KRERv
ZRy+ue5osFlo+BiAWuD2r8upediMoSNBnrXigjK81KinrkqPsumd8/1ilNUXs2tdD6nzo6o2Oc1J
OBUgv0CTXaoOR9f6zmcDxsue5E5gddYBOyzZ9nqIpK7VzsJXukm9ap0dHASs3VFYGnCZKvXvNfdr
jCpnkMjo6c/m81UZU7Dy4fxm40IWh26VRR8HYgUXwsstoISKkosatUctKb7MbZBd8lqJPWGZw0HW
SvGXv+tlDkeevmAyEL8jLq4hA2ouBnWM8UxuBtt6skoRfuvRr3hSZjlK3E5LkRiKi1gf3aHMUVkD
F6JmX4regFIf9J0JDDyKQPjqQ3yHoAeWCzpFyadIypL/UjWEA8KRBvi7MMnSx9hEPsyPkk7+Ry4j
s3OhaqjPVmuBkC8o62EtmfT6Y2Tn2eTmOvVnNyWlxcVZwuDDAn8be04b9+o5U1qhfiIpz2XXQIOn
P6E/bpFoZrmc+KXAJtDD+ZVe12SV5ntzTguZN49kZSdp0LnZnE6x/9XtVK5gL4TcN2k96u/tqeNt
1ISzM7vRIObpHUmucW80NZKR/WjLP8vRSf6LIs36AMU3DPxBQnDeNbE++a3XWfGcZWjOXQqi/xMa
SUHpD6YF/lLupFTzemxfviZSUf5o+i53vMEwctvP+ioYsMC0ok+pDbPGb6HfnbTAHrq7oBvNRyzh
i/6DOdvax8pwRh7iTaB9S1qIGNTrtQW4E6XSaei0MXRN1Bilc6rE4iEfhyb2hlRKf8TIVsV3BeJf
o2s1Su2ccceOCs92JAGINEbxARLMiOhYpxriCZczRfjB2KqVp2e50K9zg7ITok7J1xJ1eIEPYwTP
RYrnTrhG09qma6ZRL/nQyqzOS0r+5dqSUT0hXSylvghgDPsmuZvMSpkSZYiWW/jdVAOEomE0afdW
bo31o6TmU/OhCTX5d1HOiualAukFtxdiFu/VIE0viVnisRFSuJJcAC/1PxWL3XvDnAaJJ5oC4ohu
j+WH2RoHyzUSR9R3kqqK/5AjyKJrzZCshwqjxjViO3Hem0mlyk99b1Kf4XXSPBBw0VEADlcBybIy
6ycWKVEKU6rPk+cAcml5IFixOYXQAsFE4X1EZrsF0lTRLNGjxs0M5570XYK+0w8rNpyDJHN3FEIL
iRYdGFD4L+NK3qdSYElmeuuJjABZ6u4G2Ca7e/2W3qQGzGVp71A7oR8CXvXlKHaOdiKQXyqwIvZG
oNKoY3X6KYtryFJzY5768gjQuJkYAZNiA913oEHbIc1YKDIEvfg2teFwr2hNcDLMoj54ZO/dZjZX
M+9GktUNLH/iJhuxekEpphtiH4bUTC+/S/w6GI58h/aGooZA8WaRfaNl/vIb4nOIGGmcIRA/S1gq
8XoDaBKnF16SzQHvfWco0lQI4VS7dnodstqUg5EI6RokreYlos7PlTDDB63tnSP00bLBVpcNNAMM
BLifsT9dXzatYWItBywcmwy9O5mTnJ6M0sh+SnmYPQxYI9YHWf/OxiAdIGtDg37pUq3S1AzysFr2
RXCdrWb0c0wrfEGUOqph7g6z9IkWUf+tnFcL3jrDQZacjWzUz0TneE6NobuNXIhrDqr+j9HX6Z05
5Zqfm2F534vpF/Eg88PZLO6GSu28ti77t55Ecgh6WH9EGIElrFNJuky42syhfW3MCjeD0InA+gv5
1Fp2+UOfTONCTnuEttnZTwwKSnxx0t1yZQPi+ZwBzb521J39ADWRcz+HAAU6yTqImtvtRFl7aY1Q
WF/0zJdl+StVnmYboUGjUq9KGGadG4VjEH+pZcjUQxE18c9yCI5UIrazYzvRp6d7QAOWat/LIcMC
du7Y9Mo1Hgfbr5HSPAUqCPikEL3/ehzdbqoF/rWw05ndViopsAHL6sjrX3nxGd/7MGi/8Nw4GmU3
WtMHATW3SM6siRJWSZ2bfhyQ0XwYzm2M5nuFW7tPrl1frdmK/V5PpoO0czO15YoAKbOIz1GkXoe3
oir/KKxCcBmb4EunpvoHcpQjPZ3NWv0ZZfGapO3IU3W1Vr2ixfh0hsB/R5F7FPYVDzqpeO708ki8
BjrCOrSxIXgK8+9lQ27QPxVq3JMt6Agmem+LE4bf5lmVw8D02gjJDXcaK+u/tGgVUrOsTWxX1nPL
PmtlUCUeZgzWZ5VmbOhTuo0DfxxCGMEgvUYSpNIq3VRTG+FHHS70GAmX6lOMOMKILXZJfo66s56e
pWYw3js1ftGXrJjaHxmA+99KkuZfDGcK1YtDb8W5yiFmEA8a14vu5UAJyIScUf3XbGujOWOAMnyz
kHac7io0naxTQB33e4F3UwzrPGvmc6tl2XlWhp5ebl0a1nXh/FdnxUkm2zd7pFzupa4hxwyRStJ9
Q89ix5OloUNmBBOf4BSVI0Bvhdz+Rw7lu8TkJBeJq0L9MPzYllrVrXWn/tg00NXJEW3AKEgzWopX
Bh2lIVT9NQvx9r6OXGlsy8CVHHNSXT0LU+X7mJdmCYWhyaAZpVryy4jrOPBI39J/QnqZ+rmIHeeb
VNkwkJywyO4bxQnqS02KWnqZbjbRuUMt4VeaK0F27oyxfVbSqkuwrYjL0S0gF2ZuqXXawzDPw3yv
VU4UPjqpZPdeABrvmzHEJq+QyEI9PHfS+T6SpyHzbcR4Wq+Xa6zn9S4o/22xE8aNsUTg0VfiIJVg
2WvVg+1kae8hDzTpbjKG2u85y/Mfadtq91jjlMNJzcKxcS0rCcVdkjbyHZ6pcut2Tg6CZyikf1UT
4UpbqY0f0+BId2mvZr+6uhHf6gJzDZgrzygflV0Q63dZoDkfp1SbklMTll18Wm4ueOdmnhRuNCf9
bxZdPCZaNyvv8WgwzZOt9l32AfMyPGh7WKy1L1Rp+tTHI1yxPOv7i5RMsXbSg7xFVaOKnSdEuiSB
esAQ0wEz5/aU22oSXYtOC0qPjLj6kWVQ2l09ro323DiznN5ZZqD/LsfKET5vfglMYkRi7GfdDFlw
TI3gLOSwKjy11bvYL5ouZAvI0lhP7qCMzXOACMNi3V5q4kEOefa5bdEYlj/IgZa6uEUiGTDOUntn
9tns3NFYQnZzxL/3SUiRzmkwh+e5DJzHptTlj1NEZ/quCtssdvPezD7TQc0mVlMP65NobTu8NJbW
/ICUBC2vgpba/wzVeVD83BEK78Z0MsQliqF15HFTp+7cijLyIsWuBt+u+vxujJWq9rkw1edWiYz5
nSONzfe6NJ1fFnYS0v0493J7H0Uhj0MpjMv7ITIj+xS2yQBYa9QyxYXK0j7VqZbBSUUEQLpMEnpo
UDkD5zOeeePwETEwPqWasMM5n1zITyXpXvsRKde4+TCrRRN6XUZl4saqqBAi5vZrgM6ccdGLufpU
lbWYDy65JZF9kRH+idFUWRfhL2Selpviryucq41iOGLKN6JTH7tDV2F5UqfgF1FaCNwWdyAATmV2
TrU4/Pb6Bbt79f3pW9EcpwSyGruMqeU1HTgqLLQsr6laiyK7Pp4yq0VZYYxTySOeyD9eH3XnVgLA
SJuSnglFlzV6K88jRDeGRQqjiu2HDKtsV1hS8gMV1KOq/t5QNEq4+TAl4hZcld+gqrbFuHzcedZT
r5/Q21a0vPA7jCneWrWkFowUKoxl0sxt30mzg0YfM6wu1EJ5ikl272vUFw7y7N35LECYRXuJWv5q
wYwW5hApDPz5JgrwoQtCF5Hk6FPbjfUBjnpvKBzn2JTUSNFBWg0VpCjA4/yOKkCrJo/TmBkfgnwe
RrdNxyF+6ysFqDYuQDiZgx2GT7NKVKAVak44IB2pmqnsDVoUnzWlPsL670yJJGiRkSIdQsh19aac
zHQuKYsmeJRKP9KmyP1RytUroo7D8+tbfJOXkwuBvVqySoe1Wo9kotvfFYvKHuJ4sOpCOelPtkHj
LBaF7jqUXA4+4HZqdAPkhVQO7IHS+eqZN8jRbEQtwgphwsltJVm7RyV39kI0OQ42+s7clsoJm5xX
x1b62uoDCfoyboR5KPI7kRbpqc7a9iJKufJQkjlssmubCMncyMwpblAHAFv+MkIChTHMNh7Sm97G
2eQLhDglfMW17EMuJXP9W1VSUqFIUwd66Gk0vS9GPLr6aFIUd5oSdIoMgsBdZy2e2q+v83IIXgZv
ai0w64ihi4r15pDoUd5HOsbPUmY32I4pwYcm6LqD3bQ/CnQGFpgu6Vp8ydFqimOpTYW6UytfQhT9
HQlK/+/rc9k0YDmD6LjQ+4SjR8Vg9ZktAZhHTFN4E6na/wpRSpjdcqwVWksqkDEX2RpHfKgKy/pH
mwq5vkdFLznCpm2niqcOtyBQvwW4vC7QKb0mYO8VIT605gR0KArPulQeUW92RgENvfS2ZQMf6PVp
aedy5PxSXEogyd47wxgZnpVUdnXwyts7lX+QprS1EVtYN0v6ThhdVaDEpxvl/BCI6d/Mmgq/iLU3
O5AvmwPm9PKWpC24Rj3oyTA3SL+mSOBDzu4Lit5wBCVXjaojuNHOPlkA5aQLGEducT4tWDkZmW0S
lhLdy7Crre8OTN5zhnrp17I0zc9Mub9WcQipWQLed1Dz2BJ8lrkCBKXiCVAAb+SX8aDvLaMsKy71
qbXEeMmL2HRcTchOdbKqoAhcjf6n9aHGxvK33VZK6rcOXRw8UwOkH7LURtijjUzLDRXJeDNfnh9H
zwocFGd16y6CiJijNQYVZj1MlFs1m/qFRod0KXFOPQg+e9kbRSaVZjfidtxrL78DilkTJQYWAktj
ONO5kr0zCzN1hwFojRsFdFfKZj6CuuwtP6cTRM/Sh96wtltcGJCxx44AA3rjhHwFQXcQ5kXjpXxp
6XZ+Rkt89tIhuijRkR/W9u4hS8a6hUIj8O1NvLW0ATPFitRRSEb5GTM6yQ2RCHWDXEtTF1si+aA2
vPeNQYnDmQPWQxV1+Rp/ZecYQsqB1MIbGQ0j+NJHoeRhRRS4aTvkj12VzEtF4u1hg1n+/0HJkV8O
iugBmVISk7UiAX8x0F2/H8TC0BeHivM7kRAoCbDTJf8i7q/2ENhq0dkwpm/9qFKmoEL+JAfpUS65
/C0vr0kmhEfJIoK66JMuy/rXV9SiDv55wIRoPKrPOAjn56Y3Cg9NMl3hksnNSxIN3ySl+R8aPgvk
HoAeo2/7IsAyxtZE4A7KdKxgqpuFTxm0wIM4vzM/UI9YE1HWN5c2zMv5KXZqqkMuSVe1ywuPRq2D
ubcyU3oQ6ju7SlQvQlj+fQh87O1ZOq9D8w/tBjzG+oZRjUjuYxSOb3EYoFdnSMEJeXbb78I5OjgK
O1uFyh4LiQIJ/q5r7Emo9YNKpME4F/WC9/VgKT9hyCUHo+wcODpn/ESG+sPQfvkp51jEndQF4a20
cZU8KSJUfxup6SD5M2a1fYa1Uo3XMiSHfvvb6v9RsmhtgZNaA9Cyoq9LWwWq0Q4UXZworf14mit/
LKTo+nqqtc0LFmCUzUlAXBYQ0eo8DEoTZ4DZ0JKvYkxPyUsLgIphfMbkSP0fpkX0WvpoYL82Zdm0
T9E7D6wQScOww14li8y7CSIqbeW4GI5sOvdmRp+FNB0gMsz3ZRP9ddKH2nBqKW7iWyq4iSxEmvxB
BIZvx9JRb2dvPy6PHQB7FunVurhtq0prZ+rMG6sIwkeqVNNF0ob/Xl+pLbYaH3jQzFyvIGvoF60m
VDq1MZikGCiZRtUp0dL6A7JRGLDXg3Yak1b4dJTxIk0k8xTEg4E85/RmNAy/YVFHQN4NDR7y45cf
NYqtLpED0shBzsU104Ry0QYk1UXYTAe7Ze+jcroXaT6FFHyzM6XYkZMCRdU0i9o7e0ymy5ja8QG1
dPerQkYGQkb7CgmX1YzoxND0hEZwkytF9aNStc7lnM+uBRfe6+Qu8wckFb0SJRq3nrr8gwj0NzOY
lq8KJQTEPcKVGzxkPE19FspVDJ+2LM8xD2tQl+XggnzJDr7q3qngfUjshBQP+np13iO8sKuuqXF1
H0M8w7rJcutxrH9MzWE3a3coqN7g5ngIbK5aYWmRbkA0v8G8T04q0mi+NsaQoWPtzdhVJFZAWnI4
eJRCUFk9GBeFMc3JlByifVd/BDhjfUGdBMUEx4zMgyfw8oVWGcQC2mA42uaIaaxuWInTbekFui5S
1vZnWZY7d1542GqdSBe5qOxfr5/7nc/IeAz3B4i2Ofay1CWhKiOc01VzHqFArLYPGm+H92C2goPd
sXPloSCzDLWgxzcs3V6vBogLC++RznjiG7y2fWQSnAL1hDTnf9DT5ILKrfXx9TnuZC2QVLgRQN3A
Xl3XVWSj1CoUZEkz1XI+1WoVE9/k7EnrGxmh26Shv9HJT0WWD2/PWiiQIbcIa2WpLq7Ow5jnEqfE
QAehHUbfCKPIxyExO435oUvwXqhhj2KGuMjTkuquQk1jTsh5ZXiL0yjUhWvF5niqVGU8J4VpQuHX
VHHuzNK6qRLAK78cRWfeC0frvr75ay+pIaUsCnXb66qSjDjMVAmPg6CrHyMpbTxqOrQM0+B3quLp
K2Nf448jVLPXB94J6Qxswo5ZxM83Wxl/em2qTFL8KFedR/ji+mNbJfHp9VF2DgzFbyI6Qk9cHfay
yf+6+IswE9xRVAVVOtqfFLkbzmo4LYIah5qnuxP6a6hVLMAxtLdGuli3dqxM31HmzLfk7qjMsXM6
Fn9inZrYogj6h1j414SAuUZVs7z80mHIf8LdDT+rcHguFTnHVU+KOIFGaBS0/8yu+Pz6x9yJdi/G
Xp0PVZv6WuYddtPTvDihzWXRt6fgT/RQ3Jhve7BFtoT6hbRPLYFKwpLar8tupUiaqZFQlgL9GUb0
osPsmrSp/ZVKC1aAQ4emlduA8vHlKQiZuZNpD0ZYzo9IB+ZHiIy9vbToFlDyRZIYtZSXeynRZ1Yf
X74bVz+C/RbNuUeTlnjl6trQfXr7t4bnDtFdM8AJ/Ykff60zVatRc+iOIy5U/SjosZ2jBJ1lmI6x
nynjm8FBfGnkSpZ7hVC/AX44yBiBTp3o4MROdYt0vfESS5f8KDSNg0LZ3g7mRUrWSInT2phsq5EI
hkjDU1eradIDFw2iD4NUIpwedSAnBiukNF7HZjD6gIvSt+9hso+lQkhY2OY8tLWn0UBT8CbHswni
Q/yWJ/RuDLXqPiRWkh1s4Z09gyoLni7cocSg9ZWiDJo9ZcCPb33dt++RjtL/E+Egvle91B1F1N2x
Fnop1U9ziyqzDboMnYmaTmsZ40MRmMZVAX127Qw4lq/vzr2hIHyQkBs0rTY3ZRHI9MsUwmrU9tG7
WRrmsxnm/adEEurl9aF2wio5LpEbMgvl3XU6lxaDKZcBvcVsNJL3I8DgO3AD/8M6kZby5VToUzvr
FNB0Fra89DJE9H1qWuG14D4e+67RDiak7hwAGkdctzxn4MWsj7aEjlwSIPVwG+zZkgAvV1Z9whld
d84jSI3Y0+o86TwIZ8B11MIyfwWFjspvUmvyj3bGnpmnSTkB0TSU9FOTj/yRqB1MHFKkvkHMNwv5
760xGXA6BxJhK89tlK06BMRwsZ+S3nMiR4p9LIfY8GGZa79xtR6Ss2wEuBDErQ0A5PVV3NkwdAGW
3B8m1GJ5/zJ2AgrqgMfDZkBLVZygdU0nB9XJp6gZ3r8+0t7XxTUSBCByGjyklv//r8Ap2WnQ1Kib
I8KiIm8M4/Rij2Z6waihxKgtzz2tC0cM+fDBe33knesRZDCLSl9/IUKu5thZbR3kaomxWJ/kp4Tv
4Yo0HS5JG7ZuXsj9wUx3TgagVtq4OjfSFqxHD3XCuQnYc2fq4aksg/kbyHrnIB3fW7k/pPGl2rwD
i1CjaAYKF9+CGZJe0qvDszSgTob67lHmvzcUcGdMjACN8s5fLx11QiMMZQoKtVn6Ig7rM0SRzE1h
7B+s1ZL3rR5uMHEXrD1kKy7z5dv+vUsmmPeyGmDRoifScDFbTXxTJZSsPKcM4nM+JvkHuKZV+D+c
g6VHjSgYCdymZyoGxZrDxGbcCHwZpKnxex6M77rAEs+v78bdj8mtA56TDGJTRwBLAAbWMOKbJYUJ
cnOh7iE5qnuTUh4l2Xsbf9mC1LKpWGwuuXb4U6ufYgSAptwzIcz+zIJM9gwnnB4sQQHl9an9cUZa
rx5S/yRGkKrZLquThqGYCUQQGSBriIxvtH3VrwIA5gcZcORXo8qjT2MmcOiJrTrqkWMP1P9KevIf
bYg1sid3ljR55DsYdVq9KK4IEnSTazeY5g24oLbnLrH6n73R2BU9OjHCdRoNkfu1Whr3+lzoR256
O80ragdMBFEj/rEuT3JX9DqyMcmt6OyerqyU/1vx7v1VWknde/qs29R/anX0Z9oZn7XBbuaDS2kv
lqAFtJSdFvro+jw0hj1atbCg989G+VUzgeSWaTgeYDT2Th2oJxqxrNwiA/3y1EESantjQQxI9VSA
d4ubyxjnnx1nFHdgTmvPwTP57vXNsncOKLou0HAwBJuH9szLswl0AEO9Jf2CcqQ8VmkS3alZ2x0U
TPaOgb2QiknBKD6t3wdzSIGChAvUxSxLP2xJV35qTZaGiJvN5cPQFEeCY3tXnQPM4w9SG5rg6nNG
DvYdprHYdkd19cSRmDwnxnCqkmzdlauh/aI10nTKMvbu6x91u5AaxSzYlqD8d8A2jQY3pSyJ1K0z
ZCdsmAewt/Z4svGX9cYOU0uRG9HB7tlOl0F5x8OJRM5tA9CbBRlMkmDcKQVtcadK+q/BTHUvm0MV
t6PMeGqC0vBV/C8P6kI7rX1G5mQuitX0LNanw54MrY4HHEb0skq/0R3MDHeI5xkqIt4CJ3jJkJ6T
OkWBoHWkgbhjOF+CpinfCYydVLchhVW9ps+io9C7Vemh7wWqfSE/aDtQH0TQVZVHIe8ZI7G+ADwo
wN6hpR74htIXv3EZKw1A6lLy1Ext8SsPZxIivVW17ylo+9mlc5hnB5fcNpjwmxC5gfHLq5KK2stj
rpRjKWUdybScd+2d1qNxatZwEl/fg9uDTVkBFBsaBXsKjVaR0KctSbecIDduvZTakVdlsaS6ne7k
RyYze5uPJxxIL4oRi/TWyzl1Sh7bnUSITqNYus8zQ3YdORtPPCblSy5r07kLS/1eR+PnIFXZnSeP
KYgdqJduvHRgL8B87IAHAqAAVd7D1qsF15ikILz0+ifdm+Qiqg29BdTYpt4itCbJYVKS64VRfo3g
EcReETiS7tuZVGAJNwX2FxE01X0yo9t6sG228ZPWC+kK0n4LeGSdP4dJaCY6K3gT2tR4UxanH6zQ
ity5HJKLrqbRwZ1n7UUxuqpUt1FIWeR5Xq4p+JwpFuViVN1ryWOstkMJEbgqWvD6NRrweDPmNYsL
QN+bSxtyakbH8qeVOo19suxuLK8g/af6GYU3iAezZsOejYZ4eNdrc2t/7eNBak/UzJL8cbbUkqjY
AQnxed8Z0l1tpmNwwX44Tt0mmBTHj3Q88M6jcBrtlPdgJ9FzDYrGpVTRaWDTe/E4mH3SYh0VmEh/
qUpwn6c9iPXSns2vdKPt0JUjUSysi1J/DKoukj3wln0Fs78tnzMrRlp0GCWtPCHClMenegZm71pZ
Tc0s5F7E1kLP+gUxoyE21tP4k5h0XMLdgH2EA1c3aSPiTWb/ywDNqfqDMVp0OOs+45DH9mR5RTPj
J6sabQ21rZGKwZ/lpgXcP/ap6Vaz0at+1gSmfVa7OFLcrJLzkfMb6dVNSrCEP3co4os78jjtc15U
cveYwxqofDH28nuZDn/sdoHZR/7cDor2/PoR2Dtti3TnInhGE3e9JzoEHri5aLdPSaj5lHWwJiQ9
vIihbQ8u0d2hFu8S4gm6R+v93tKsFrGZ0W535vxMAKs9RFeC+wYD8dcntXeyloGwBaS9ucm7DBjs
cx739DVRetDcrjaTZx4h5qUd7faXIeQjgPveDUCpmNbYogm8Sbpaa+5BbQp4v7lVGK4UhAJbR4mj
dBCx9mYGBY8a8UJp3IhGyWZn0kbAXHuWk9obaMf6nSJal4pcT3I/HamJ7a0ZrSn4cdR/uXZXIWMM
dMTEbax0NHmuLngqCb9M++a5o7d5en3RdodCEYtXFb4RGyWQkIuml4souZly19+HaITflEprTtNk
6v/DTiRBJv/XoIYqa0eFYgISlyUjX7Eo9JPUpLorwqg+RToo8bfPaikC0Zo0l9f3SpqsNc1RiyrU
lKd8RItPGsbkDi2xIOD9hdr564PtBHgYqEjQUR75o0q1CvC6MqE6sXjgaXbqabNjdy7w085FoaG6
tKhIv+OJf4SL2L7maKfBbtQAQfKg01bgvCorkR2VSRXyUY9/0bERp1RXhO3Wxoi/NoX9gFaFCX0T
IqFjfg6lzjnMC7e0R+BK/HFUhCnoo9/4cuqWXBOSuVpukP4tqjWFkN5JzoAUaRWJ7AExFjt/DiG4
1ojfQ7bwsLmpPueynHP1xoi2HCzFzkGF5LCYKC21T/q7L3/PqORqb8YlKtpjiRoeCoxunZSqa0R1
ejLb4AgCv9M7WmwTIFmzyShLyKsP4IgBMJVFNhGpieq2kzPeiW623aSKLD81RHpnWmV11sM5PKXz
nFCH7YLbbOPu9/om3ImFC4IddgxpI/9Z/RClN+Q4t3mlJVnW3VmBEX9wcj04vz7K7nypsNJXoaOM
2uDqYNV0AlFGxkAksRcogp07Z4yddRzQkUlperu4Wk4Fm50nglcbSIuEDRgXndrzQVq1E7fAJlFx
ojnAT1nPFz27srRQLriN0xj6yP0RTIx09nDZPioE7W0q2OXozlGzJ4Fbb6oKVzO14tOm2JG6OcAI
b2Ld3yUkGf+aodUf3KM78QTbImPpRzoqAkqrk50r5dxKIk5uWdmpkqc7Dzka1JkbyKH2b1/IzXPe
29XB/tldWSAr7CG6IEvP9+XRyZs4iHNodjc9EFrvymVjGxAm1fpfcsTqCdWO5HMZd8adEU0PA/L4
PPUK9dpEzZHW/+78FzUikM5EcHP9vVWT+c4VS2s0EhTNKOvv6W51780u7i48xusvVB3Go+tpZ1g0
C+AscedChl+Xx8K2pUJHRfWqFCOuhOVsR4qnIWV6rqHBFB6EaDSEmspGw/H1U7UzMvw5uoVLbYy/
a4XSqKywMfs2da660VpntSqKqzNY40XSYXomaP3gMFMciXPtBAwgs4v3ykJj2FQDNSRGrKhg0Bgz
hzMYmexk9tQ4/o+z81huG9nC8BOhCjlsAZAUFKxk2R5tUHJCzo3QePr7wSuLZInlO17OjJsAuvuk
P3z8aGeOKZZfjGToTtB7PGbvgKZ2mRMiH50DXQ2VLk/C3jT2A0zcCxv4zPNg1UcbmguX5thxzpSs
awpUkVu/BXXhL0avP4gk1y+scgZRgy4wT7OBEVnouELHMtQSOKsg9Ipj2RzMolOecs0dSAvnJFP8
dWxt804F5r2x+NoO9dl0aJLbjsZO/u+5G5+Oa9hDc4BNe7RvEJiNnVgVyXVMsbhvIL+/zIVj+amz
XtIXPPPcm1wDqGSi3JbtbEX9X6MMUvsSzBsob7vGXrr24lUSzDXt+6BXaxfkmteJXduu8XO2SQwE
dT5M957ojZ8fb6jzP4SUmKgLFeJkrul2UzqNhKFrqP4xjlJNFuDSamQ+jbIYZtyg7Ye0lYGe6TKs
skX39di0f338K063NW8DwYc/TMBTpzXZNVaLVa0SjWqLyDO/B6Eo10Z52KounKCzD8xG44YgzWDL
6e/ffNtUZjollhIVm1tZYCRdbvhZY2ANW4KeuIKdrotDk6pK7jvxZKX7ykr6a4SQ4ct9/NhnggRg
R56XxihkVYRR3/8WlvMKYVkJs7MhBbbdtPZzjtjbpypppx+5YmTYOK3mkyx7GY0NWtc7HEJNw6/X
FI2uj3/NaQb8/sccvxhNJR6vcPb0Wq2fUstB0WvWpHPb5e0clFJz0RiC7+S5yUOLLti/XwXkewBb
OYGIKKJn9P5ldENrjBPyd9fIekPkNylj/iCjv+PgQH5bFq33SU5NvEfQb1O5U7xr3oVSX7gFTi++
DWpOygcHztkM197/jNxkMyb2mFwXliOuKsuWSrCW2TBeWOc0DeLvplex4RYZrRx/+0Y4XqrMGmwS
c4F55OTgMq1m3K+WnfqIoimPH3/ec2dsMxWhteyZROWjNChFFWc1vYXbrWqVcFja5dCv0+ijWOFd
4F2cW2ojkQGe4fFQiH3/Cmt3Smp35k7JLSXzE4Z6YeKuqPTVaDxcKFHOrgUmE6TgZuJiHn0uJ7fq
qq6L5Frk6QCBHVCkNagL2DLr0rjt7FIbPcCl7GaIsu2cv+7sugBAsKQ2orelmj6iSWK+VPY8fcLx
y/v28cc6twk3PLSz4XVs2vHvlxpiBTN2O4c/a07zzmxjZe8UZXWh/HDPLbOxY4CSkkzQ+Hm/jFEl
VhPPMo68bFyyvZOZqriTkJ2TB2Fp49esL0otqJyV6fPUduItg7mTH1BPqosgbbzGCggQMgPD5+Wf
K7kM+T6Z6BX7nZDqz6UndPptvDQDGjN9VmD+Ikrz0JNZrOG0SjqXQ2onvzMz71ufWIQVTWpkSx40
felMoRgUCHmrY2VpoNNR+l1D4Kb+sazlAY+iJfZpg5XLfRc3bGcVUUwRzJ5eUxjnveNcJa7amcGU
pnZNSC2NPWJFVYea3Wj34SSWxdvR2CgmDBnAEt2p+uq+5FqxVLd4+QrUqpHF3Ekzx2txwCjrqnTq
CnyI06b51VrYxqtd4gjgx/WYxLtimar14JSzMuw00SDb2apt6d6S7surJEGw098kRD4ZSgMmWs7K
+KV3yyqOUqPvf1LDe+lOUdviTu9Eh1jPXKG/AndPjDsBhhz5oDhDHbKHKt/4gzokz1SF6E+kCcaz
/qDj9+bXtSbRIBp6moOZYjZv9P6z/EKgOHMOQANtQ1NVsyiqjnKXOGMcrCOjEuXmXN4Q17H0LRMg
Hyvd5vTC+T6dblDwb+4whGpkN7ztx/x16OK+b4yk7rNrz06yHfOExUc0fA2rVRU7mOthXZXIBzrp
pYVPqwiQM7RZtoahBV3z6GIZ9WY0esdNr021KL7k2C98nbU5R4xdd0WEtTCxWLSJfeF5z0RhLNks
OlGbKDtUnffP6xppPHaFSSs7bYZ7l5dyhfT8/Wy6603umT8YayqHfploxDdjd+HiPjMzpWdJDx1i
ELAC9Cber+5Zq2ZWYsyukRGtPWSapvaAORPNt1HAQRx6c2quEYTUBx9BkuoVnNH4MBoexSSarYW/
aL1xyNJxvvr4Pjyz5WjHbIMml/h1AqB2qqRas14FNdVgpUnopH7MxyVcGIpd2N3nvjvWhly6VAGE
laMNl6Hipa95nyLhltmQ+tcxKL3ql2okjZ+PnrdjZnxpMn/u8biCTQ1GygZvOgqYaS6rcnYhKkIz
1/dcIFoUo211myvaJdXvc0shWkoRSXW+Efzff+FCAD8jwWJba4xbLWY/4dRrE77YtTx8/NHOZDjU
w0ySN5HUzf/l/VLx7LmAU0yCWC5jw29KL7mdx2YSjN1zccighqkXTs+ZJRlHbvPIzZySrvj7JROs
WrDdcxOsxtp0h9GA9Zn5U7L3UrS1CmtRLhyYM5tlG/IyoYGQddq/a3JjpoOBTnbm6YTocXmu+7J5
BZdtByvXpG/NUv4fNxPgZN7sRpaCZnp0M5XAwR178agds24M+km37xVZUzwvQxkgviyCpW3/2cGR
r6jZNOQR/0Mu3j5a1EYJz51scrrFatDbS+i7OkHMgXD+j0+4ZSPkqNSkwODef0ItGRoEw1YlMnCm
9pnapIGRN264yZEdmqxUdh/v0jM5EJ1/KD0bkphm99F6cRFXuSMWJeqLvn113HoM3MK6tFG2v+U9
+G1jIjNeYGRIV+z42CnZtOZO4SpROdT6YZZjHTRr7QZD01v/fuwYg8LPsdmUlPRHJ1wu0htLj6VM
PWnuZgXCR2V43/K8c3cYfF5SCzp35P5a7phQmoNhtpkPU7unXuanqaUdpFGL0EpLfQc67dJM4tyb
BIxGcLSYcDjHOmPCSAfpxIsXSXOdfcSQm2ukSs1gnBRxAat7bqmNfQzZeRPDP25OyRYah4Z+YjTI
YnuWpr0y24W3OMIm/3gX/pnWHW0QdsgGQGOIfdqHGXrOVuGkGMPVen1lIzU+7u04Tl7EhMpcWjQY
Hs9F7xU7vKzzn7059rM/03oGqDRKTqRpSHe9ErWBmndJ8Ww/q5m3is9I9ZpiZ2Imowbo08ddWDWr
aj3gnKYf3LqwvuamaObAAptzk5a1/ew0q/UVUU1yd9teS+MTTTkn3hPmm59taVRoM06uuIuphZLv
Lomn9OF9YO+VLQDLgkXX0ix0wLCr/qzErue3JhB5H61/4X4f1kmoO1isyWuGY4n0S2tWzcjta3UO
4kydvhV6Po8HVFusL/TjCFJUKEjlGynidaaiJYU/OYMEeyCd/HdF65zx2Mcf40zOSRuCP1v9SiDZ
9sVfOedq27mdtYg4p3ph35RzEYdSQ2l9m4JRfFA0K4BEfpVQfC+c3TM7jqYrzCEI9uiiHF8Tg0YC
pWLHiymG1exn/ouwTAf6PdJanj5+yHONsA0rQYqLICPrbbHtr6cUrSLAmRlKpODgdyWpbaGIKYUk
v2YHKqVUfILXHPSpbd6btfGGUEv3+PGPOH1eHF3ApzOeMJk8HQ8JKuwQR6sGkliJ1gtsYLxB3Dvr
Z0MU64VQfXrPb0oz2yQTPWXIUkfXYlWZtZPYzONnpl9XZLfKVVl04++PH+jcKi5KQi5LnOmyWCsY
nrYmfcfZUbtt5GxGiKHqlzBf2umtizYQMjLMs+wNIHuU6IilQzgHnBVoPXd81JiavRXTstoB8mTl
FACxpoWOMoa4p5oVL7gLrAeZQYvNVs1+g7ya/cjn3gOsrKafJTYCVzPb+eXjl/EHGvz+UqPNysgJ
dTeS25P+Ju2aUnfrOb1Gs3q4bujVSF8d0+r3pLjJFWUFAnY61MBbWScTdW+1fq7WYt61ueKE1uSo
+8kZ7fsptdfo4592ZuMxrUGag3ENMw7raDek45otmMOgne4O0wGbwf7KivG4qW2tDP99KVgDQH51
6mVUtd6fM1dxGYOVyKoIZVRDtRzxXKi7eFcaxUXpwzPbDzg6TAzCCFjO41lnTVoAIo58NIH0/TbR
Qq38hjZjcYiNcX6z0fVrg5HiNfE7Kx7vwfhMkw+kSbzZtDXErUiQvljMYTKBhNHtCZfV07+3QLyw
YHYhy/joV6/LPk1UQWtPabrC7yZj+IyFY/bV7as59Q1m2VdSX/IyzJNY21ovzfLqWYBxQ9Uax4d2
w2KHhr2ioz4oGnLSVbUgqqUlVmtBnlKNN8EMhvZv2Vi9PxFDfi9zk7q+QEvfZiAh8y7QMRCJ6UY3
2XOXrt4lkNKZHbJBKqmw6UYzEtr+/V/Xo8LEqxhSdFUqN5sCfVnrnQ5s+3Exmkv4pG2zHR2TDWmA
EQITB6xBjjbj6JWWEXuUf2udv2qjkR5WxRKBWxl9qLuD+uDBhgixpFf9rBbywv48rWHgA9JwYNyH
GA8DzPcPqgGrcMeSxnBvFGpY9Z4IoSF3QeJ5uAvDCwHW2F2S5jn3yAYZ/mbhiljn8aFIZqcqFFSm
rxc1d3c985dI2MM2nh/n+KmOYwnyJq7iQ9o29BW6sQci/PG5PHeHbqSlLU9m3kAP9P2DI5UzSy/W
Y8STRcG+88oqYgwUe78lZg3aD49G0+hPDD4iAWoyu8LhiaC4MkZXdn1t6g9zkbtf9LW2fptzMyMB
6kw079dZuQTPOPe6GEYA3ac3dKYv05lA1Zw+jipsazrgIYDm0DrOyAFbmle2L7JMd+DurEt/1dpJ
qr5o2WC6F17ZmesFLDU7FUwQuGr1KGWoM5XKqOhJTwxPBrNulw9mLdp/pmRQILEdYQxsTNXjikwU
hTMg+61Ess3UObQUL31aElRsg0Y2vb5Hprn9/PFeOBNO2fwO5CTINKddkaQkxywGEUdGgfVn2Cut
fRiqSXo7wEjes8tw/+XjFc9cLyBg2P8bxAha1NHmG7QY6PmQxFHPhdiRVO+EQb9gKYvqQu/sTz/2
6Hohl0dRDOndbdh0FICsoouLTAolmhdbuTNTr3R8itFVDbJ2Wb6z4Vb05wFcgUBu60pGRa5l32d6
N3Wo1G3/htS70fmw7bxfsY1+tG8qtnZnFbP1gCXIMvuD1uVasGrqgkpjpajDvp+U2rqWekvXzBno
oP/SBvRcAj2ZF3KAuE08RPGX/mmcMwxNdbnEYPsKvX2xsoGmKkVSWuGfQim5m6ZuAoIQj+I74xak
kvRFMT9P2spwqW+9+kFhUhp59LMoWIRiek9kJeoNDmaaFpqTaTd3XN+LeGRSBcraHfNqDWOtBPc9
md36aJJyK4FbewU03KpW+qusqJFDd+tOS0NF70081rBWPHjQUctHUn8APXoj0YroXW+xAqTmHRFk
o66OWGC3432nir6ie+owPE1L9WWES/I8IuvU+0qqTHdZ2bUJojNcycG6AOFsKs99NgwKKoDbk/PJ
APD2xdWGxgU4g+h0mDVOZ+5Tpqbg3Nd8WcN6XZfOr/qJYRcOl0kfCN7L5K8Jjkx+V8epG7qp7XIf
VXE5hjjQ5GMIG0ItEWRZPQgmS1PCO9ETRfWdoq3/gymBLxP6n/mXjzf7aYjB+BOKuwvTDa3P45p9
6oXlMvuzIpVm8k4oevatRPV3r1YT8oeLtexRub+Ud50pcDa7UXY9dRyc4uMYkwqKGcvq7UiiLoZK
ktmZ6FyZjbSYSQLw922jT36VvYHhGd1Jl0+ip70sbyAsFcOFV3B63t//mO1q/SudQIaIj6M4sPuL
KglrPAl3jd3pu0W9aKt35m1jqwhdm74WI+ZjoqVjVxysWTcjjZszAN6vXo9Wk1ZYWK7efuWg3AkD
dbGPv/GZBwQ8SxLDJbMNTLYr9q8HhJknsrGajGji2jzEttqFSBvAzZgvKc2fWYnCHKgA//CUx1ql
mbBRv85xjRkBqIedsPInoabqTTda6bePH+okLvxR1QOoY20wNuLD0UPNStZOeuJFra48rbzWa20e
PntDhobgaiSXgsK55XQGawQEnvBk7KvVZgMsKcfnFKuT3ZoKMyCZ0AIvj43ArNZLHpwnb3KbrG2V
CXknsM9jRVIMJ1IrVlcwerFTvcSTiMFXKfictvWqXJKfOMlhtsVo2CGJQDQ6abTiEphYJbKCkVVk
WXxVgyOygrLWq12n28MYrLLDb2/C5CHhlkzL+2Fc6wticedeMPneHxakReA9+p6rzjgCb1Mnchlb
3yXSdMrDBKS2I7cv65uWK/RCZvFH2+dd9OWxSWcMtNupOE9KMpPbuwLY40Vp4drDVacN5RoazNAg
BsPFmABVYT1Ra5kFB84bayPUxBT/HOpZj4QzQl5O3SJ5abN0Bt/QDsUAtb4Ul3peJ6kdP5MGDGNd
YMD0+o+Or+KuhB8FN9gOGONnHYnhX85k/LNq/rYK0odQxYB+knW/P0+eDlsNgyJMX+tueW0raYOx
ksz4ExSSXj4+u+eeaKOJAemj/XBymBrDm+OVeUaE2smyIyceb7I208OPVzl3hBA68SAVbTJDx0eI
7K6qKFbY1flcBAWWKgf6q60fe/RUP17q3AGiqAcXAjeHSHqUx9nzgOMiKP1o0Go18R1rMr61xO3H
caziryWohBTXnKQndY0XEHw2YxN5oQI4d4AA6qE8ttH4eej3H1DDGwm/JelGEnzg5glK2wAy2DDl
NHJrRY1wJL303Gc+JK00Ti0lgbnJU79fU6LATWqu2xEljRvWddVdGRhVRB+/3T+Qy6ODSoVFnsLl
xIV4PFYze81VchV/twQWWTuEzTrM/Y78In+uEBQQu5xC1g21oRsEDkQ2Ep5YN5X9AwqmQGjWzGq6
AAcUxXrt8dd5GGOMUHwg4kkSqNoq5CcPWZz0U+ykzTfRWEK5WUeEsQLpOcnPyTQrcmylXvfI7XpD
oFq4TJmxglfTiC8CnkmDZpRROzfxF1E7+U93LIpnrLANN0TZR7pXuondTDD33fSqOhKMyWLO849Z
mM0lCP+ZTb8JIAP92AQd6Bm8/yLqPLlOMeN/5bh9f9DUZNjXk6HsG1HU+48/y0kyQz+E0RxRHlVD
AuPRUnUp095WcOKW5NoBYBDPH8w0D2G+rAdLryiZkBHbfbzoaeNyW5WOJbNO5vEnKAxauEVrIZsY
IdGj7KnLa8oB5jfPjaZp1xmpZBLUzPTulqmz7tehqO4UGhr3wi7yyJ48iDLC1O1XDzne9EI9d+Y4
WLx19Gqg8fPrjq4BApe15i29AF2xmx+xYq2PMlm6/+e9U05AxNEpiI+T59wYHJF1rhcpDRp1OQJB
TRCXqdnfOhAaxihXhuZHlxfaJdH7M7ccqcgWICgINvL0+73V62Xf9vkURwCTGfV4wgvXxYsDaef1
bs4b9VospbcTWrI8YdT7zyhYvjztB5JLNrh5st/w5ZUFMvAeyaU1Rq3wskDJy+qq7McWNSutvO29
atwN46zv29LSL0wpzj09gDzmMR4pGazP908vNTsvtS4jA3Td/ssm53BvGY3Kq3dQ69OGOuy0cvAp
IOdgcdSL6Ogz9zsukISzTRSGX7Cd/L+yeJ5XunFdxpG5sXeRyxvqh9wtcy0U46o/LKuu1FSIffcr
X+eUjVc4/3VWat6A6Jg1RJNXY7kSDDJf49gkSanNLHlYYEe3FwLRuSvIg3O+8fr/iAK9/6GyL3C5
nkhd66zvXhc9dwAL5JI6fDaS+UKQP3PkwLpBbmfquNWwR0fOSZZF6RPKAB1UK5NSYf22F3X87+Nb
58y7p34CIABMl2bN8buvU61UFaUhABWrfYXylvaSSiH2amwqaiC6f+a4wV5mHrYhOlDcPcn+C0P0
7dynXjQXdXwYEBLPd0419tWFyvBU7oKFwJgaOuAtRhN/3B7/2lSrjhRHnJO41JrA4qHUpO3SgxiN
Vzy1lObZi+X0fdBNxHEJBOJNLzMTuxHPpPfs1Fl7nTttNv37Bnr3o/T3Gwh7SAfDxM7Fc7GXe7Ti
40cdj+Bdp8brhcTttBOxvQDQCkQy0FAkF+/X6oza6ZtWdaPFjMfDnIJ7ymAg+07jtVcVt00A0cLw
OTIZBpcLTaqxLosLm/jMieFiM+nyb10RAtv7H9Hm3Voo7UCGT7i9M20FPlrfxNeo9l5ykD631MY2
Y0KJDvFJml+Pay+tip3VmCL5PYhp3GFVLr44dvP54zNz5mSyccHqbyx5buyj9ECz6KRlYOeiwRrM
XRUnzdM6pM4FLZkzJ5M1NkAk2OXT9vDqMri0erJepKjWL2oq8qsZj7GHjFedBIU32t8/fqwzYWCj
IG1iBoRCWtLvv5XIK+Ekau1GzQBM2XfmLnstFydfvqVaBeTKbLz0be3L8Wkp4SEHExqqlw7IuV27
MX+xn0HtAF2+ox+BaLMzdPXsRCh/zq/M5uJDjx/x4LuTUed+TAmQ+pD56pWBRN/fgBFYr6WLL8eF
83OCx6DQ2FpLxONtSnV8/co1RvtqVK3IS2l/JqNr+Jo1F7tcQ+W4akvxKMdVCSykhC6E4z/x9qgo
gC3Bmd30TVAIPDo0Dv4wzpx0duQ6rbPuzGUw914BsMZvk77RPyFy2fa+Ab/0qvGM+HMqnPhz7jnr
JzkU8aUjfCYZxlhlQyRziWzkxvfbIqbESssytiK96gdcefg+/gzxIbSRRdlrbd/u3Kpf3z7ejGfO
GBKJDkqCAINPWeBc6IDku8qOqtF+7dauvoGLkF7ozJy5MlCUBvMM8Rt/nOMZKGVlCYudRxNZP15X
6tKhGy5H+R0fNLvbffxEZxcDpMH0BYA3RitH7zFPNlNtST86r5qoRrrlevMZDb1hNv89W6cDDU6T
kfY27zn6ZL1a2XFpL1ZEFwd0RtWKvVSt4sIJObtPSVqhzBMWESk8ypoXtTLmWOZWtJpLV+xcta5Q
/qnK/CnutFwE3arlt2PW5EWA02D6aWyBNvn1MmOsW6sVisz//obhtG9+o0zPT0bantMMQykLdqre
pDcTjaXGn+HdFaE6ueZ4IbSd26GwV4BXAHg7bS3SqzSX1R3sSGG8FwhmSQF2suWFkujcroF0C+AW
YjGh9OhTmovmTnXDKozxIesZ1hwUZif3oG/G/+P1wcInnm24KKQu329QpAxbq61ZCj5A4ZfevERe
vnhhnPTahaXOvTu2JjfoH9D0cdaZZr2ythBEI9VRquuJ9UA6Lpf8xc4EE0RltuYf8wFcRY9bBh6t
Ehc+OEcuq7yfAkfmOIhXIWZ/tSVSxxrQ1J/kSDYaR9Va4vnc1EVomDNNrY+35mkw55ds4L5NRpZs
++jdDgkTczfTrMgBRHU3FcXUconayYTXsFPd6lLol+qHc0tu8KftJGz9paOdY4NYzRJSxEiHqXYF
b2mTvYFytU/wq7pejPFSN/d0q9IeAJbOR/1jy3AUummiT5XhZk4EgWAK86pP9vSTrF3dgyj8+HWe
XYqGBMJxW/P4eLpsLKoBQtKyo1KxK1jTKgZjSJbuuyFXL1BEt9f0PhjzVMx8yKYdcthjtQwyMAbN
uH9FRts7OzVepr0U05uWLeauyB1aoqkbI53VYdAg88ugu40Od7I+9d/G77dt0NzvT6WaG0oK/MeJ
FpyJwEAk/TOOWdqNOsV4AXfafFiNvhn9AuelzDfqdP6ENs8lrMK5F85dRzcMyMppmThBlcstM3Ei
ddCqvQ65IjANWV5pOvP6j7/tmT7YBi7k6xJbNo7q9lv+rtwaEMZwvu0I0DUCqgiA6T/KPJUULa7y
uQTBcFCsynvu+8WOlqXGNX2Epnm7lup807tGdxizKX9yxmL5/fFPMx399GuwvRERQU4Q4eHjc2zm
Lo8O5jOKi8Sb3ki/WvNxtkpNCQzFcLq9udoomDmIlum3sHoESGmpSOlvCmvafklxm2z92upQAMkK
0ID2Y9sq9dDeWoVpFQ9k/EO26yr+en/qlybzJ6fofoNlc5tfsrZFsu80EKy3Qq1z/bbzmO5+tjIq
An/EH9y91pspAS4k1Wb9Ly29oQ7swUQ3TrE8POLpgCX5G6Cfbg4nQ47GQXGMSrsSriaMwGtj2wzQ
9x7j3w42WxWIgwUxtoBJdpLfDdPcI1EKPX0JJzTjCUdmM76VdpoXexD5YLjSCmG6IFHQFwlqd6xE
SH7LTGJAXlfep7k+0bhXvKH0hz7vrkeZzbGfwUlYfGT8EbBD80l/cLOGCUo/dCjsFIXUqkA3soHc
E3i0C9Jomb73VjPZQaanYxqq3cj/2Wdx+oB0XjdeF1mnxVdJ3Kn6Dhc7cNtD4s3Dl2I0Kt0OHZrj
zts691qyr83BiXetAbB7t7iZxBoCDO1afgWe4ba3S55p9c2cW7LZ9yUlwfe5qRY1AN5uT0G96Gaz
y+oRFawG2c/+US1bpURndJWvfWfVZgjTo3wWqNAr3/Htbj4lTWGoIaz62pqjYR20VvijnajmXSnx
qgk601huN24UaIpJWN+dUbfiB80e6HajcNd9texuKkLkhQGPaSIFhQWzWld95OBQ/UV3RJ0ONNkY
20lvAMiPfp7l1/qy3FYdbM2D3bJ/nmDgVm/MOJzOp11fpD76MNo3GevKcA9ba9H8XsP++ZZBj/HJ
mux1RhPLzH+O6Je2X9KkLOWBhvN8izpWUz2sxIR0lyWWnvv5VMjBF5a9XOOSM8X7eW2mL2jB6F4o
dWV+0mLLulHVQvniSf4gWiwlQThzqmCUafxfQ11n+WofF1M4C7kiieBpteP5Y+akawDPpHmrGOYm
gWm2xkNPl2O6sZH0QdFQ8oy+UY2GDFqjw3sr5YJ5ceZavInBHfXQq3JGFyqAnfGmiPvKOBRKZoxX
2TTWv+BatXNY40L9vfLGovMLz+oNv6Ue3a/Czt4ydENeKwfXVd9WS4TCEmX2XrIhVTUGX4U2+sk0
Lo9Kq5AM5nmbDb5nMZ3zx87OtL0JstPbo3OI6YtCHR4uG9eiTSdHo8jLqjoSmF/Lq8Ko2pgfaWZ3
Of6kP8Xsal2oae3yMibSTkMsetwHG5W8egrtfjGcx0WLKzMwsni09ozX4Sv0ZpsKyrNRU78aA/KB
UVnaSXPTQ4mIlaC3hSNDA940yL7UAmpVtxsgsTcdCux5SL0YTYzZIvUbDUN5csy2cm5ouImXSjDo
e3NlATtEDmOc3ml9rtlfllwWV2Sr4OmzJh2A6nblMoubpUiM+N7Rs6y/y63WaQIkJr0bRuUi3yWK
J+9aT12+T/lKEwzmAK4DudaZj21aCPVhRYzK4y5EHIartDR/aMxAigDCqrdcG+5gTgcmkcPtQifA
9kustBK/QfgFGUmw3OIhyxeglPHUYYm4whLxY0ObgJ71ef11xqwRxoM5rjP8cppzD2M7lJ8UhN3j
qylui2k30lJK2HSVtBC5y5qntqk1gMeSN9ZZa/c8dEUzf9HSMS53CffL/TqK3IHvoqivdut29yjq
ChN9y0HVIHc3AlorfSnpI2+9Or4rhPPgIP9mQvhBf+1Wa5HZeITCJ76tvcL5MBK3v+tt9vY+JSCA
Fu0LN1DtpcsD5MA7GdgG9lthjXij/Ir/VSH3iQGe7aZZtQwjmGTJmq+pMgjtYEJRf05HWTt7vq3r
fSLayzHA7my6b+MmWQJAgfN810oHLBqyMI4IjaxfC7Qi0Dn0y0wOlW92aloGTlNO3b4sdDvZtzX5
NDFOG8udoaOIT0aiNXurwt4syJIJ+NdU6NaP0VyE5tejXqIATxnn08lj80p8w3xHls3TAvTlu6aM
2S/H6Y2HskI8Bj5jnf/Mhn7+qRaOnYftlAyOP0MtUMN5lOYzrfIcaKq2qrBk2H9fichDFXpjI//z
tC5+nuxluGmWWv5eXHthbFzK8WWi8OaeqBchfOwPu6+zvpZYvJbK2u/LSqtfHGNo/2tjLXummZzi
eFOU7Q59Tw1HjGxyX62CpjH2r3VWhDXaPb9tl8HAdaymUxNpY92k4Tyl6n3jKkUXIfCcfVpHd7aD
Akh57IsJo7kARan0BeXt1qEqYVcHuepUbSTAf+Yhg29b3orGtr6mYIJi3CFGR/VR8V5+zy4jG6S0
cI5yYRPe9Sggm77VW8gMl7aV3Jpl3RY+tJYUoXYp+jCeBu4zq3BWesFCDHwy8IGPFQMXxpwiWdZA
qfPsx9rGq7mjqsBMyBTm8DoljdZ+XRa3+sJwcVbgIjWo8tRWyk2LtZLiRKNs08jFaqLh3jC813mS
7Q8TGxtzx1VUqf/JaemsfdzHGmYNqVTNneja+pPuVP1/BhqDRPlZF3ej0uvfaCiINbCMYVx8Y6KA
8Rudv+/QNjKzw25YwL34olxb99qBLG1ADhum3i/6MkMXAnE7VM3tpn6c12Sx6H1X5RjEgxpH5JLO
N5tqrwjoscWf3Rol28CV3dA/kEPqxJcya6HternXhFJR1h+1M6mW34y4rIQ9GAWKR8eWxvUidDcP
IetLbbco5aIe9MnqrwZNOFaoNPmU3pa6sz71U9OZB0wk2ePgnpYvfQmgMhiF7oxB6npFyRfpqLiL
HmwuWCQLtzwShvYTTm6rvLLQSKXoT+L1RSQpT0krUD5VTTZrgWnPKEQu0qiUFFJuvNo/azF0/deP
897TXihgk61BhpjppkJ7VL1OE6fBTAstqpzKjAolH+dQqAVoRkNSA/mJGic3A5rQt/noaN2FCuxM
7YFOFApZpJlA1I6reOjiaklE0yKv9LYsLckeoANXfmvnl8RJziwFepFmLxLpjMOOiz0u5KpUBHcx
ytVzmCxFHDhxPFxJ0f6z5A8PhCI+XR1To718XMI2hpo06dxZUT0Y1i5GXH2fzFXy+PGXO9ME2BTV
6NzqtKlORruNqEZ1bGYrAkSsrD5MmPbLwp30bMT/Y+48liQ3snT9KjTuwYEWY9OzAEKmrCyZxQ0s
S0E4HHBo8fT3QzV7WBkpYnpWd9FsKxYzEQE43M85vxobtJ568vX1Cz53B2G20r+hFEdRfdKuDnZT
ybEIYGRSV26NoTOvxtLDyqsQ59xTn1mVq6M7gg6yC4ixOhmoTgNKQXIHbbaeyqi3C6bS21jNcXno
Yq3dY8fnE3TUjSVnozLSc1EcT2/tik+sK5LRAOYNJ99UijYrk6qCEdol9s7Ts/jSLCDX2sGgb3DT
m//toS6WTSgnmUMA1D95lIWBhhDZvXVc1vqYQX+7MYckONd9r3ft8byBywDH842YrDwR+hteyYlT
5/YR3lOP/Ndp29ugzMsm7MRYfgczKW/ntnT2IsU6LgzcXLmrQsjEGMvKP7++mp4+YqhRWNUBgjN6
eOJs7C/Eh3oUuEcCLKqrIKb40Eyzv6Cr8+5o4HJcsoI+9G0p9q9f+bmnCyHiJ574zNy1K+rW9NrW
OraN6d9N/WRwgMxyZ/d+eTMasXZmIsp048mNJwedK/o8Wmawp+NXSRe3DL5p4iCZag8K/8qYaA7W
WOgujVVETdPrIurKYRgiV/r6Eoq2ba/q2NKh3ZWEPG7nBFU1ITVkf7Mqc//BbIm4CnMgrDy0E32o
N41OxUQhYFUkTdV68DBbzYL93upAtik8kZBXbJvdJzsZtOnTWNamiJRdOveDLmyOIS0T8NYX5WI+
HlOS65jG5ztbkwimlqZTVMUDnkG0eirTtsIMuviC3xIvl8pez3H6NqPZpArgTWDkPPq3MbSi+W1b
e3621Qap/P1UF+mbRumz/WdjWJNFTpmJDT7tgpFEinkuhj8p5UuyKVSAUF1Hfxjvq04j8RljruYi
CNpq9Uhfw9Bucmn00wEmjYl/S1ZOfojmU3MjXe/ifmNnFn6pfq5rxh6UYBKbQUscd5cFk1FuKHHL
Hh8et64O9eTRUJllbOa3yk+0/AKxSp1/8LAR1EIfn+DsEll6rbaeshWeUqTAk7xmoe75YDOhuV0m
JBRR7nZWH6k+X5YosQgICN0W+gojvVl/M0l/KK5h6zvvFifIqygNECVvhzQx5NYIkoo0d3z90QyA
/dgHNVTLwzQtxscY4yYKLalUcqUZXluGwJdUFrasJLY5mcyaPTTN+k0frMw8DGdkQBVsTut/iNHm
1iTpCAkvWEYazrG2+IC8idK23dBkXeThCMYoqnfyNipV0N5pli8596lSup3W1dyDSFSz9b5UbtEn
oQzcsWPD6Iv6RsZZ3fzIl6b85OqZS3Po2LN/mRl+coVLLKmgdMqijyBmxRd1I0jxDUrNx2BUL6r2
So5m6xxmzaUtRYkvPwZlUbuodEyH9wCOx6dh7N0LpSYz2LezkaOdl8l80RVOU4Uqc+JhP8rcWDad
6xf3fYaoE5/JwU7DYhLWu95RwWea2PzdFNTmZQLOrEV96sjiSvmQoMOmKrXggAFCf13YM2raUSxe
fiANoY2jVoAD7boipyyUcM2rDZGqvQp5VXXstGrTvxEpllVwzkus4to6KVXkDrJ6sG3CEHkFi+Cr
nch05L1ZlL2llNaBm5ME9RG2E8YSmeicHEwxq+Ftr5e2uNILHDiQqc7xJ1vKRRKy4Gf3dABeEbmF
s7wPQD1+DEutL9s6Kab3YplUv9dwE+iw1rfW35lPmdiJZnDfJku3CnJ0r2POVzrljRqKugLXdqxv
NHiLdj2PQf9uLDHuDQcU7Pq28LNaoNKaPW8f+33GNE+SPLKroOJ81wpXzQiY4IGGgyUtSWaEM7/F
0bAuo5QRshlapFTIY6DKZp+1MgiiDlf5KtLnINEjGjRZXk4ZPMRoDPSMh9V36MqXoLeqMNWseJsJ
FQehrrm12NGvW/TuhIXzUDVnZ41pD3hlxNNlbw59HoErTRLBt4Kx4FXd+H7IGh8EOzDb93lTeeYG
1ojrRoZDbw2wWBDMTSbYfdImtrl36mTaxPmgcJcDpEujLmn1o2isadjKptH6SMyQ146TmRA2YQxx
/oaJivunNPu0OVMAPHsYriHQ8LSwET0trewUe8NR1dZxLfXCKuiqjV9b2a6Iqz/jQLr3tEiSYWUz
7F4/C5/WdBjEU9CtTHO0NqcFuJYPqBIt1zy6RbLggeX0m8kUPlMtfT5zqaeHIJdifIUDGsIN8gof
z/4ZbYg8dxLrWFvxsilkm1x3LPdbLMjznbDAPAfXc6PXv99TNBJGH5HPuBFiXkPZ+viigzu3Vb/k
+rGz6/oY9PFXZ9bPhTQ8U1CgQ+H2kcNI/NIpkKuGtMqIEdCPk9G5deT3o/xCzm53jaN9UG9bP3PO
SFqfeWysFrQ7/A8S0SmpNXN7bN4TaznOgndMd9IMH6Uy2/WaL89QVp6CZGtyM1SNgDqYYe/JYyN7
0RwqpzeOJKAs26VxzS+rt9geUZt90WDJENHfNbgP9HT5+KeeKVqfubf4RLnYX2D7AMHi5PJZKgqv
AK85DtjAbZsBDq9w85jCZcmjfrT/Dy8ExJS1UPvpuHFK0JECKEx2+nJ0MLoJO69pj6C7w9FxhuIM
C+ypOx7sARbnyr3hBlP5P16cjeOOpdO7+lHGFW+2rnntw2rSX4fGmDZfg4KwHJyxrFKFeR5oeUTL
N3VIRRvjpu9qgdbR0wdykqeg/LebSz4aXSXOgSvGfnob7Lpr3Z7TGW/SzHnbWNb8xRimXGxGX9lf
lcHg5Myb+sz2QDMAMQrnM3JcTqHBukDm53oCVQZ0i+Ogt9NmXiwSGR3VX6zph1GPbvX13eEZFgFk
fNKf2JAwZWKPePwE6MhMe0C/cWRq563U/wZEqmj85RNO4nAJ6rFx4k1Lc7ZT2YQdktFJuRFl653L
6njmjbYdRAngkmsG9+lrpnXw7g1Z05vNi9jFzPGOpt46W6Nuz3EnnrkUBg0MJ9YN8ekbXXpdl8l1
Km3X6ibO/O5GGB1ODaVmbl+/v8/svuubhPcxuCp+qicvLzKbtmpJqTiajEPrjRY7wABOJY0ze9TT
b8SEelUDrv26g+Xh48dYBeVkOMtiHZ246rbGWAIOjsBFAe6OZ5bMM5fiSlDEmZp5q4HC40tBiHWz
uKB5NEonBiYd+2KP7Y87b0WP48OZl+LpDeToYmEydeGAQWD4+GoY5JPop/nmcRkQRjADdq+XznbO
3L6nrx50RMjEiAlhzMFKfHyVnHTVuqgTHX8qPbtuHKrZzJTulTOjCx90XUWzVRgP/+7aWDmQuDjC
6X0mtgND0NizM10/kvQoL1u7Fscq6M+5/z331dhlIZsyKVsZeo+/mo8eyrSJ/zyiBvNvTfgqgKVd
+0aIxH5f14Eeh3MK5fhMy//cZTmsYFqxQjwCaB5ftuMIyZas14+GpfQ7LctxHiqcbDcAZtqRIdCZ
UOXlQ33muk/XC6rbNUN2ZbWwSE++rjmlRSaJrzk6U15dQfYvN/Ng6mfegWeqVYoBlJCo2qCwnr7W
zDJLzVG2fnQnDgLkNOhrdtOc5+bOz2s1RE7X519mJmhAyW0pzj3Un3zKk0EWAULrdNBk/TzZLFFn
2H3izgZVHWPIsMUvGfmKKOkKQR4LRc8zj3oIJ918i4NFgP9DbdlfMYkL7gNXWV91MY33MbnoBBCB
td70NSP7aEpXP/ER9PJPYY3m8GAaffs2aMDvQ72HR3u0cDi4tZiZPYjUdz4rM0vrDUnrWht5rdf/
2Tj5cmm1otMwr0PksVEzPf2Zh/xMSQRrd93oVifjJyE/Tu5XrYDtd7RINmAaM+FOriXgvjRjEUKz
/kxzcrrloQnzV4BA56Gv/K/1738h7bTSMkvfRZ3XD2kDcAZSb2uFijSZquPrm8JPduCvT/anwBZu
MAxCaOqcvo+vhaOY9BlbTRzIOYhfGxvtTaF5k3mzCJj0UdBM3SWWC6QVaEmWfmar1qrQGQL7lmrF
v5oWSC8hYjLs9TogcDPKx6qp7nM7nr2bGk5w1EBOfphi0uG/NU4RXOlj1+pT6Nep6zJaGB0cDQfH
EBucLJz0tk0nB9S8UX0VTWuSWJQUbpygN/f0z8scLMQZYiPa7aZCxyrVVHUzbbTWLdpIW+VXIalq
aKz1pamTQz/p0ydHM1Nos9LlC3bS95NNmo+qfDOOY7tzpm6Yb+xY0uq2eL0GB3sMMutNbSY523Iy
CExPKFLVkSFQluwrOmj3AFFnJqPQZzD44fUncrqT8UAokAywGeJqn+ol8VgpNN6L/pj5yscBAru1
vRXHfXE5gL4PB+ZS5n1QpVNyThr8pDjj0is1fdW6c9LCFnu8FkhPMW1Nc4ej5TeJiPxUkR2VjlXy
p14Jb4hSIkS0C7fDYvpodJrxkbcVi3NZLNDl/+27wIHPq6YD7cBtXV/JX14Br8+hxTOfPbZtPGwq
PBXC3Mjdr4ENo8FVUkW21yZnjuUnJGxuAPAOVDlIc5C9T6m0JAcwGlJVfxwhyg206G5wa0gmN7i+
jbic5fbEvDCd40q/llOCkqJO6s7daLlq4ewYSX7OJ/B0K/AwGFrPF/AtDlP++fg+pGWWZ9hXzke7
rILbpNfyo6+P1mapW3Fmlzs9yrgUd3tdAHQE5hOCb4GMlOZ3XICA+vxgd7K4UPDv9q8/2OeugoEM
PHcMu/ADP5kPSBEssWYO+nEperlJF4H8uCnOCU6eWcoWUMfPcB5u3hPWvoPr0+gLtuyMRPTValzH
KNBvt17dGxtTrFn16G2qrL4MtNq9McpyPLOJP32P+QTALABMGGaA+D5+ctXYwtuxZ/3Yj0V8gHKX
HWoUubvMi72jsJo5qtxkOVMoPOlw14fI3IU3GPtT2sn1U/3y3lgDjnfFiNsi4Z3wc8zYI6dWQ+Sc
7vpy0o+DErXNVJuBoGHO4BmDrdeXEO7SDts/pvepl2geREmMU858tif6/J+fDasFVA6cNU+OtSIJ
MO9Iu+VYGIV5WeWju8INfv3FW4itgdQyyAm7OEb7m3Yda8MJCpbyqA+NnUZwrpMyghaKR9SsxjIL
W6+V5qHpqDYirSMgNHRx/Woiq6O+jeJ0dD9ZVutOYaPwotn0Zt2+cWmyp0iHxPGZkOFWYbRdD4zY
mf0+jLz9t5NM8yaM13ImbLpalqGe6OMPci0y4LLOy7PQ6RgohwVE+zc2tvaf9b5T55KsTgu+9VYh
HMBChsf01B3UdlWcBV27HBvHiG90p/SuZJ4Qq2EvIvhWwsr7Qahx3+y8qnHfv/6GPrMLglQyk8Ef
ALTuSROJpMxseX+WI+zdrNp6s+n8EAlmFaEtpDetZKv4ts77vIhaNsdysxYRn4puIszBsDsA1dc/
0NpzPS5RLBPLCma1a0FEjf94TROvhGVd3elHNuxRYww/5wP+WAS0GRZO0mGXCtADA8aX3My2lVFR
6pp1pnt6ZiPGkJ4CnM0LKPf0aJhsrUziuRmPqmpyKA36vNU1Eb+jEFRntshndg4sQKnHwH8plk91
nnYbxxT7y3RcmOLf1p0AjJS1isZE6RclO/9Girz4503+j6/Tfybfqzf/vJ/tf/8Xf/5aqbnJeNNO
/vjft8P3puub779dP6j2NzaEbw9dVpX/tf6S//mhx7/iv6+zr1Bpqh/d6X/16Ie40l+fZPPQPTz6
w7bssm6+678389vvbV90Py/AZ17/y//tX/72/edveT+r7//4/WvVl9362xI+/O9//dXx2z9+X6uI
//j11//1dzcPkh/bNd/Lr+lvENofShbHP3/jv37s+0Pb/eN3zTH+WOVJyG9p2qHv2Bxv4/d//pX9
B8Jc5qa+BUnEwnbi99/KqunSf/zu/OExjUEKxKAJ+R2Std9/Ywq+/pX5B35b8O5oK6g4fprc/OsD
Pnpmfz/D38pevqkgAbT8tPO4VWGz8KheUOgwVViNzy3z8btSd4YpoNg6FCbxAHCtLWYXzbav4De2
YrDD2Wz0FgaJMxUoWOrxs9WkNpLmToCA4J25RNUEt27TLTWuBaoiJTxMrCTZQx0y7B1jPbHL8q6T
285ZxkPVmbW9pQrEJTwTrjaCxib4E5NtLMKuSZPbptUqov98O6nDRGGhG8WmSmE7GcvCrgwn+ViN
TfsjIIn446AkIFUeq845LF5sT9HQyKreAonF+t6eW03tm7xfBEqGNJ7eQSVwL8Z2aKeIm998ZqnB
TTFy372rq8m6cxMOlYOcq/yb0Ob6rdADAYsxGUbYxSnAlNkBg7TTkGs3XjlOh1G3akD+tJ6/S7PS
zU3pV97XvjLTe/wT/LeOVUgkq5W3mFd2bGhWBON+iaOKE+sD+CNsWjy4cXOHGSy/GWbsyo96Alr6
EdcoiMexZpN/4huD9R5yL9aDiefhnqQvDhKiWA6kNXXuBDrYg9ISNs9Zn73RZQIJWQRCjkgCrZ6n
mA5A+X7ea/U1JrdScq/F0ux7gnaYwqVJfcG0uf7GNEvPAAOtvN413uxDPMkLiyla3JjzVgVLdSN7
ROQhWuG2J17bYtzdq2KRF5kRjytdoq/BXiVi830cOOK2VEPL4zRdSTS8hPEXIanuvqXBZDZXvUg0
bE2wvb2fdc1/KM3R/uamJVQTkKb5o51rySeUJTnfxscGaGsq2+3DidF6AtWcaRSchLHlXFYowK5t
LBO/J2VdyltRt7axI1SNbgFa35R/6ODI2ZtuKp2CxthaptDsubdh6Wbi2kgxGwkz2hyg70L17lvP
Q1y74pz6kcYrMTbl5FFowNZVEq4GwdvvG3IxOFkgD4xTWCves2iA43WPs720w6RJpi9oIbEshn2Z
tZs4m5t7WU/GZqobNN6NdP27Ks0qbWcNnIh3BulCDZZg1UiUQ2GPP5ouDrKLos3T9IENrPN5CWLL
u5StjhhEzpgrbKhp2zxE3erGuxLSP3lRLUVbJJepdKk9irwPjSLtoHF7mBBGdVszGRB5kuT7hfiU
ex1jo+916XlkTrqeMkIT41QgC8saJc/Kqg6Tk5R33dLY086CKstqEqz3TebZS7eBEmL7WzWVvrXJ
cthtG41e/4cmEqVYJZ0G3z73zfbKHdLywcNMiV7dtpp3YrTwfCAKy6Q30wp/iUr4EfV1n1bdtDVh
4RsbLdFxMRyqlXWEIEeFErLyzjCVnh0myMb7CU47jJZCH+6Wqo7vVZo065yl82+k3sbNhp2ve180
MoWRbFriPZ4eApMZc/I+JVIP3ioQzjf6rMGOx8kkYlLUVxs+TtpvqGYqODtSwhmu077qeWlBl9kh
s0/UWtNDDPbvH/2gT4qInbqWoTVl1OnoTsrb0cc8eOuOJu9mUubjm7lQhhXCh4ntSM5CUCk2QDwR
wHkQs0TRGWx8U1BuZnnpHZLFxZkf++F2uijifho2PtIgVj1JDAX+yYP3Vzv/b53oL57Oj070/+W5
///jic4h+8qJ/lCI4qH89tuxXf+vfXSo85P/OtS9P2jSaEWZttnrwf33oe4afzDsBKpfgTKauBUP
+OtQX2uBFbRkyI2IDRnqOjT961TXHPOPNd0H/S+/Euqfaf7+bxzrJ0bXGngYKAfWaSc9ZJP1mMlK
URywWL2d0qUO0ZVkkH4yazeRJfun3gqNAWEx3cPjEFGVLeNOKsON5niaIyIggr2+QAIa9Nj4KBoG
Gb/cz78KkF8Ljp94yN+1+d+f7KTOIIJKH1rfFofCSuWlac/qSkwNubdMy6/hpsWR3gQOtToEe2OY
0W1Zy4dBQ7aHvK4uoEXBOLKXItnoUHB2sZnVGwvoau9V/rTFlsl6e+aTPtZ+/v1JT4ZaetW77JZC
HPrY8COr6RtUcwpXfU+kX/XCTi9de6q2wwLwHTqxTelTt2dtKF66+vrvf+3H/TYOGOKKgw7Hasd+
PG40tF1bv+Z0adJOHtpKFVE6jmqjjBHxVU2E4utf/XEz+T/fXGft/nrtihBgAkNNcVjKhNNQuUN2
l6D4PGoQkiIHQtDbzMrmANAd6e3r13zcLv19zZPxDrbruqkhZD3AQpO7EcOJsPLL4rqK9W+vX+En
k+SZpXc64vABGaS+jOIwGEl6uag63YJEVO+lm40HdE9rbJgYoiCZ9chTsjzIZeh2frLciGLcBI6G
3bJdTteBaL+UtWvvqszs1+zm+Mw48act0nOf8GR4qWlFhfR/zA+myKc1hiHfukAIu4KxzcFa9PIC
TY24wJ9fQol30/dM5lFvGXVAMhF+NHOcIDkkQHNviYmEkNEwb9TST5dWreaj3gYwpWqvDeU0d2fm
ri89t5M5o2zHrCtwyTks8cScM2Amjw5o2JfKe/f6c/tpmPHcXWGX/XU59qlICqypq0OBhIk5E6Kv
tPS1g1Oo6XKgkApNYgT2WotYZCnn5tg3NX4G0hhCfeqNO7/J5m2K4e1tJTibNdzlPnVlYh8SlfYH
L5+7CGZBiSlBUu8tKPrbaaqGvZMaBFO0vbEVxYwm1JxwGYrN3dBhTmsPfX0kSRcdlMNXbsjvubQT
u4YSDj0UkOt7S7rEtYllzW5MGusMIeWlu32yr2Ncgu8mYt5DicFptOo1NzPEZCjKs7d7/XafTEL/
fhNPdui6IVkqmCdut5e3O/zmdFTKWLJ3ZX+jEvlpjJvPdpeWmxGpdUhUxXzmQRvrFZ570Cc7LoLN
3rMbuzoIaFNM5ZzcdqMRs0Y6oXT4LvGeLOldCs/d+N4sSP5SBnTToKNDrHFa0Q8LtI9zk/QXP87J
FqwmZLVL5XCzlbSuxkUMRFm1mTzMswP1r7QvSj8ptjW4Jy1ENW41Q6BoamuIxGRpntkYT6Zr/3oe
jJIeL/+hdHjddaM6JEGSAWYBJIgB34wmiT/UFiN94hTJqtVBMpGy+BC/An/v+6RXvr4gHk8I/r7+
yc7MTNbWaHOLgz8OXmTQnm2SqqgvS90vKFTdcxy959c2SNLj74mVLm/W4BcH4CoJidh1OewDEBSj
fv/6N3k8J/v7m5xsrw0WukusAnEQoN6bmEy2TS60gCdo9HAdc2Obm7Px6fWLgbQ/u5yfpGDSa+Lp
TKzggTjd+Rt5dqgIas+bL1xn0YJd60wo5gX4oxf2TVFcFomOlq3r46kPlR0U5MDQ0m+Fq3Cy11px
nbsjdyfrYjcqBl9cT0WDwtbIZ/2rY3bxA44FBkE76Aw+I//uP6f6kGxk2qEBhbvWYCqQojLHajcn
QK7zYK/NZRqIvRsjutX9HploFcQGvEgf1lg4T+Z124NxWnFh9ltwl+BYzK1P/ZEZ2rIlwRg1qg6O
PW1cSrS9W5InsYHL37/RVnQ1HL3Su00cX84hlOD8MkM3bkQT3GLk8GS+fJrtRjDA0eS07XAOIn0Z
J/DPiO28y6wHtbwZgtLYImO3rYgs5oREOfpEVOgkFbhRkHq1u01VmeysqUq6PdnE7nurz3FsmMtq
+aGhrPw65lmwNWPNdw71XFp3tU+7G6JZsK+a3A3IwAocY2vYcaa46FwiuR6kaYdF1Tf3tGQILYOU
rxe2dbA0W+lbjXM1Y4FsaR3/ks7+0FvFRaEvxEqUU2YwU8EbeQAn6fOHnMnIe8LOxK2gHT/WZdHt
ncRkdMO8mycPHKD8cChUOtNw22N2aOc20zalGTQksJG4vF9Eady7+sAcfVQCwftouOLWzb1Au0g7
p/2OMLX4MeYquCR1UUGdVm25pUiotnD4BtDtDEQiqksE2FHs9MgujWby30t/4SkbeIq/XZPUZego
04eXkcFi1hZsCpkg2AJqnRUIDEEHQ96PaDcYYyyZjVhekZURpoRISCwrU+seT47hYPmi+ZCXef5g
CNf9Km0NMJzAk7n8wCQeHNYZFvJSbXfqNjntd3LnZlZZR4bSAJxI1aHgNAFT34KsyI+JWZV4TRem
0A9wt5hlWxDgdnEhSvtYD62JDpIwsR22DwuzvtYtqW2q7Kp15sDCnG0QTYj19xBvXHjbDIzAx+9w
J6VmKHsdJ1U/a813va2ZySbrwDZDYy6Lzagcd0MqN4YCTYBIHiH1hrFAvDWYbXUhYVe06DndUxgn
+fI5mJ26RiWyEDZuxlP3rlZOWYZAUVq+03uFM6lvp3t7GglXIoWlu0sM1nXUxz6LvcAokcxl1YW2
M66DPSN3tk0FcBJ6/VIfNGIbdlNbq/wW0bP7DpvI/r7REX1ssQFmHbJ0ko0zWZzWrm7ld22a/lQD
uIS88a7VcP8b713cq/KHBq711U8GA5eQeXC+k7LiZpFByBIjq7ofPsDHwD6CEXbwpRvaLkWCYJXf
q8TOP2RVi9cAKWFWvynsabJDbPtmI6zRWD/UetLf9AggP81T3+9Mrenfu02mUFvEEMk7v4rVNna0
GAVXat74rb9NJsXUTfV99gNEXG1z6TuhnzrqAmH/9L4zJEOwKZf1A/mUDP5SqTf1wawkHHR8CYtN
UfnW56Htp3SLBvBilHp6rLu4YRKKdYE6+FNRgcLNOb60duGZ2BUYyxcRNKo7zC1hZluYGtpV3C4Y
dbApSBzTiolds1Of0eDO8kJXsX6d9bC36x5/v9DCN+GjDeF0Yjo3+1cGxprdFowJo2htZGSXxNkN
Jr7ahgdZH5ya3B1YSlXWR4FYcuZv3rKZZVawUXRzdhiw1pErKTj47lRoF7eEQetfZcJwLaShdAQO
dVP/paZkLXe+YvMMlWckMnKZTF3PQQWmWbiNO4YEkudhU3rpnoAdn6QYTdmfdWJrHoYC6nJYtCZs
m0DWmQpdIVjP7YBEjD2cPTPK6gA1l56mzlUw2byHrx+BL5zo/knl0M1G5U2NtfYGEM7qRJQsAQxF
xIifwOuXWHuApyUjvODHRYOC1TMgl6toBpDCY1BTbeB0GWfEzy+UPv5JweDHY7pIzy0Pde00ERDN
+6qRwWVbjDPOB2ft7tdK7rkvcdJDlcO4Bg4Z5SGd1LLVO328KRLtOlHzcoWpPDXwbDSRiwsGqqX4
XBqa9UI55J/0VeUkJyNty+ogY73+KPyML+RqOfu1VtjLfWa5ehpCoEkoBcYEG94GkYtFYJBcmiiu
NXHVFc1qXxBn4gdwR/WxAmjxw9YdGm2fVwPmLeXPMkObOSSXEpb8peXU1X5Wcnyj5DTce1MWCzhb
JfkBhBYzHMfEJg6tmJdwrwPPrnK4mtB305+bO0MgrQN0b8hrnLp2uMNqRXwsZ8mwyC7r6px970sL
96TNqkcLowHVUPl3M0Sv0kqOmI/NSC6tc8T2lxbuWjT+Mt+ZetnKWlbVgeluA4o2W4ckn8/Jlc2X
vsFJK5UtZhUsnlkeJlkBd5cCECxgYt87CaZhomrfFU6BoQ7eSTh7BHY0xZZ70TcU3UGVpTthwKb3
EZOEuV05TOfHFFetPPuo8MnZa2ZH5F0BMyV3vDxk76E8RJF3Udt+e6M3uX3m9X7hBVwHrL/epWbK
vKb225zKzYymXCNio+RVSLXs2wSEf+YqL9ys4ORxJ96SaUmtBAZEln2VgOox7af8HkkDPrMVvtjF
nTzvslxcrbCm4mA5S7prxtSOisxiMIts3tt4HD/R5OTzm7IkzxIGI97c/pLvdfIfv7++VZ5Qff5u
f07WhEfsbzAwQjloPQJlFc/z3gzK9I0huuyuTjoAvJU2WhplT+9tOdd5LZ27pRZ1NENwPKi4OGcQ
/sLWE5y01mWTZDH8SUHYMBJqv0BTLXVnJIur0iJDVtiRB/PwfxqaQFh9vIgY13gi7zgjsA9mh3MT
P6qsSttaTVy9PXNv13v43BZ+8oUmAK8465bigCtHfgUqS2JPDhMqR7WyyxbcSdqkWsuZoD3WNKL7
Iq4nbIaGc0KOF86QU4WSlzqNFD5mxM6c67f5YMfX06jye63GcWIeZbsh0zXh0ZfpPicpbvf6Fzdf
eJLeyRk/Yxg0pL2dHWJi5r/l1tg5uwyfAiP1RnWF15vrhE7Sx3U41HL80Dl2+9AxsACR6OdBxwpN
wKdDxou3mLdMcjsZYwbybA/g0R6OUR+Z/QHA4j4x4DvSFsl7rZDwqHA/qoKtmw7uZ63jYClGjxSW
2rZiKjS7POeJ/dJ9PSkwSlvlFdVrekj7CWvHOV1HxRhPb3uC2p1wqlnHoUvaoR2Welx+S9u8Sjav
39wX9qVTLuuC6LlzrSU5BKUrP7vJNG8BKKdNrvJzyZsvTPsAiR+/HD2K6EVi0nZgGGHtZuGKu0J4
BNSss1FhuPhb4ER71Gz1o+/tZoNxU/nu9a9nrmvkmZfGO9ndGYX481x32j7L0vKiVZAi9MpfPs8Y
FV8rCiKE+1ANIo3FTV1rogLWjQFqHSwC54vegRuFHeOhZGONWXBTznFsbRpnxknOGeVOY+BysGRm
wNbj8PsidF/e21mq9kGPk3ukmQi/4YPVU7PJ7JkIMmtUM7wpTBT3r3/Fl96Ok5Ml6EbQrELkh7ji
1xdiUWilu+XKKvw2yjOR35MSmZypVl+6nSdHDBRcS1VEwx6EuXy3rO4OnkxLd5jDyx+MfeuPxZ9I
v8/Rf1860k59enQ3n8mZAqIq+/TK8Pv+TscElgvCdPDMTO16DOx2RSAe4sXT7iGB6GHPu/rm9Xv7
0ttxsuUKIy5Wyqc42C1rJE8qb5uBJ+5MWWRnAJkXLuGenBwNkIs/DWV6AIrrjzH+EQg7s+qycMkR
ff1bvLBC/h97Z7YcJ5Z27Rv6qYDNsOEUyEGpebAs64SQZZt5hs1w9f+T6snOKEnRffwddERHlcsk
sNnD+671LOdk/lzdKi+bUYv3g1mahKG1asNhI79oOqM5m1s1cr62tNePL/be/ZxOZmjMKIwQwM7R
vA/cSXfO8H15wTTrcvPxJd7ZsTknR6ZEVvOKYiHfE1ZQ3xjrkcpRQRkZQGjsogGb7MfXsd4Z7c7x
Hn/bQHtDaxPNwsQFJb46z5rFDHqnjkIDHcq20kztcnT7/NDr47XBCeKGcEwyRYy6eRwrYbwQ2lyw
hhg/KzbCBLYaNRRA/SGesmqvEARHzb5IWnCncf6VNGgH9iSEBmoQVTBpGoT1Mc63WjfskvooompK
e6NcskarUeXXi2G/EpW2UEBIB/bIoCtUHZu+LpPWH2v2l7OTlLcVr3cT5R27HSLkznNMEUHfA0dd
nej5GMK0lRzxPxlo732uzslsi9mqRskg2AO4AOmSrKohRw6dA66iBudW0DVIOqHvO22KtqottG9x
346wCAt9//E7e2+sn8yGwGJLbzWNeN+XMn4Gy1bdr6ItAjHqRqCg8zVwPiz18+OrvQnm/2Z5cU7m
Q9kqrR7IdNoXg9QvpdPXGzOq1n3Tdx2JyCLZHYPHOdv0IrSkKjGCUXLFRG/5ESDcgO7+Fy8hoqUv
4diMdqdvrQngdA9t59mh1XJsEWaYjwoRclhEn7TU9Sef0XuP6mSv7imv12Q6xns5zz00x4pMN1Ut
V2tpfx3SPL1dC+pHHz+od0fGyUy6kOWUlQ2mJ1FyYgQp3e/0Yli+S7Wo81Sl6qCcvD9PiiS5n/Ky
Rg2W9WGbovH++Bcch+DfvKlTV3CWe2mqwY7dy6NMbAFMDyQIDMnHf/t7e5zT2Ni27zywjWwGYiOm
Oi4MIjvWY8IfyQGBN8/yvNFmgdRszdDNE2tIPJzzX3Eg/n3oegNO/TZNEf8HTLOhHqLbBZKGca5C
Pc/SEOfzZzGr70y5b9Le3y5BTS8D36slewmK7ckEJXSJ5O21d9dKBZzwPyvnGe8MylMpu7tUyIkc
mexzifgD9Otya04rtJNugDFdR2Ln2oW+nQpUkiRVp7eVGLUNge7Ujpwmo0tE6wTRLJhnMu3Nw2KL
KuylE/2Pz/pkhkNsbA6Ly3JddFV2Gwmq7cYqCjpStvH48Vg6ri5/N1JPprB0ceuxUWO6xzvg7RAl
Y26Dw3dtjdZn7oV3Fjb7ZNrqp0KfpZlyiT7rD3Iy0OFoubcV4NZ3MK0EGEpj3NCS+++S1f4zRk8m
G0Sw7dq4Q7rn9Q2BA1bmwJDtA9wknzFK3hHf4BT/c7lGHhwrq/A4n0otAd3bljvldeKm6DpM67Fm
hktbq3uuC/ylT5M9Duk2sGN3RX9cwbqxDDheciYX2ZuL0KqcMaBGM4RdN38WO/rOh2SdbPdGrx0m
em8pdVibYvlEWMuSyWVbOzTRZLq2u48H0XvXOb753z5YUm00IWPm785YbJrp5XK+1h4qZQ7TQVIu
n+WhvzNYT0kVXlmhEWvtlBrjiHkKKoivRZ626abis/jAd2bu08TxmmbrYKyIE5Saos06eNbl0FbL
J+vCezdw/Oe/PSjDUai0S6/ad8Qc+TAeYHSSfRm6C137j9/Fe5c4mTPytoYER7rSPqtiWnaQVq76
Zr1GxvuZr++9K5xMGbG3jC7Z8txEAtigyWskZnW33igFbffjm3hvQJ1MGVqSrh7GoHIft9HwGEV6
gxAbVquj91DQimg4+/g67ywA1slEwU/v5jE34a7Z4t7pmyuczo5v1FoRqgZQogP75eMrvffQTqaL
1WFhmRBH762KqrWo8BNnsjVoRyTeJ5d4T59xGtA0xKKCnK+yPTiEkV39HB30OdWCTFVih8Mbjfyx
IyboU0A7Mwa/Myxx6EpXbgrpfrovf+flvbkffxvkbmJTFqg4Rid128ww0dyhD3AaG89RW6OdF0vW
nSkRjR4CjvGl7Gvj2R77pg7UaJmvw6JNBy8nCMLKOXMgjSs4RrixQSfm43dx4sP89/rw1kD67RfW
WmpzvEeza47g+LNVv1+sEWlENm9Fl3ebYaaajfQQUa9Tu0FvAkynTT9uPeD1vlXYdoh0a7lK8Qb6
U2FVNNNl+3WMDXc32LAOVRnNG7SXa1jiHdlkRzv0mCfn3QRaU8FOrHtsGiPIB+AO64VaYuerk7hq
VwJv3I5xd84bbHdq0DxYkrG4mvU+NLrP5oh3VuTThPSiaTPRGAwU5BWCRNyZc4qXobvVOw6Lq/hF
jhJn9677jAOLcfPv9xmnVj6UmoTGzwlpg6unI3gea2CNbamTockmbA3JID06q/CZBw1YjEsjrRUg
azgG3ca00zTk+Ijix6Uj3wUpK61BomvDijpla+V3xMEfaBGpAKTnFqx/TDWq4tmCaiim5xKwPlbe
Wot2Q+72ZwKyGMIKmrk/EhV1k5+wat/YraauKRia94VpzDekK9g/kpYs0yOFCabC0KfOJdz7JvVx
SYxJkJkiui49DT6j0rzpLqZzrcK4cepxq8WvNKGrGkdEJK4q4O5Ia8qcFo/AUiRN0WQkBwwtkEST
MqBccDjuUppc8wYgfAwu05XFflxnelea1NYi9BYjl4RPYk3yXWBrPx0KOeEsbU2G6Wz23zqlE6Aw
uAgptbbzaPfgeVr4aWv0okMrfcTCdjc4yXQwtMndqkh9Qdux+C2O+p9Wl4xEjS2ORt+ml+Kinipd
J/kgsRQJ8D1qB24v/TEWhXERZXFkB46J8TZEggTyua2TFwGxjOZblKHUs9OySDYmqNQne2jFoUiq
dpMkbt/u9LKiUmEICT02n8DtBm4TkYOucTfpRIhJ4LJyJTclk4ERVNGYmQE99/lnrTeDukM42d5l
xDkgRHC9IkKTZUdk7UXtdFEZToQppVlKjdpn3E1Xg6cVP6qms5+KhZOnrzm5hL5N6sijm6UgbieA
GCQ2JDYMlsmdo5DUBvfLgFMnC9QaN9+zceHzWPMClmQXLwpIWGaOvo5AIUDm0YotqqeRYbwKh8YE
wobCZxBOT4th1DHmMeV+aUSU/tJQk6U7HGBlHkryAffzUGV20HcVSgdrQdniW5OZoSBx7YjUsHgY
rR2xC9MDp4wKWdiYttmWU4i9ogourXmXTxbZTKYyxabJYssK7ESml5OTrlBn7Um/neJklbjr8Vel
gjyAGKRLeukaFZYIvZl1eNrrqht+vsRFtQHeiiCu7bXqezpY0ATncYC4L71t5NI0D7BCLTeutyx4
1gpP7hRQA5PUDTikmdMr+K/kOV9MRbPkWypZLWz+NH7p9TXdaqrIjpWrJAuE0+veQdGhrIOWUPZN
M9H4OEypIVQA+D2+xfvWuHu2dDQT3U6TxWbsGl4oM7b13cuS8YsGsnn2+RLkIRPGPAd5VelAqqSe
XTsQA5/I8VDnNBm6yBdwrbOABp13H6e9lqOxpQNCM8vrsjuqy/WuyjT7FVxjEzIWAP+OUUk0xZC3
6ZexiuQPIP05C3VWzjwSr+/jTTpUNcroFpnBdvCaNWamjprLeDryT02t6G9ju9KXwKXWYQcY1cF1
dW43Al3B3kCSSLICdtHHKX/QsM1hryIU4wsyaM3yZ/A+312j5nSZO1YLtAw6ABcDvHS9ukfhPnG7
ThFmcoh26A+7ZKN5kb1uWwqIV0U558qfmTVSbJKrwfTSKA1HSdGj0BuLRdssptYYYWHiFNjUqzts
LeKxH7DJIPFWuryAP5S728Qrhx9KGbbnk8OzbpfU09GIQAekmGARtbRaogB6TDoLs6GiNm4O06Wy
IE76/H1uIMAU7Luoz8RhHFcYtNw6Sswm6YofnqemMYSBNG57Co3fPKvTma7ICOIJtUq5ZyaAONsv
e5s7YPiq83nNY9igxmpf6zrgGp88+umsNMlS8l0vtW/56ltUmYlHgEnJSF7CJXanoF6rsdvFVO6/
w1G8dMv2MdadtAuBYHjns9DinyX/PSMBfRQIpyq9tkppvkZJjD1CZQ2ZqJkj7LMYSb3cmgmT08Zb
U5ralW7L22bu83Rb68dK51xIy3daFlFCpUYVsb0Z6BWAoVpCz8tium2lYbQ+FRn9KVomUeyHEoBA
asrr0lTGQ1rTwF1zPan9VjRAISALeHQGKfhEyNkq66JAqsNAb6boZtYL2/KtoTG+Eb481hubaCvI
PVF73UdEXszp8gUN6LFR6mXVgwZTOEOqmvQ/yHWpl6BHK1ej887L58Ir+HF1SipWkEVWd6CqWK6B
wZANl6aGKDynrq6FAvbyHSK/6S7JvPk5rq1+2bmDCb3Pye1uCIo2nRb2m0Qq+CzjOtqWOtb3FY/A
J9i3+o6NUD2sdVVeNWYx4CXV45XksopU4HAmQQikDQNnr9f9Yvo1GThxoMs5GYM0HVNz12BCe034
dr+xGeiEX9K9a1AuAgrAixp367H7lVeB7kXeQItVkv4+VhT4aJKPF0gFbB9tnIk7WGg+GsCLVHVN
5c+26O/+H4R9J2Wn4O5UlZVfUZLw0xKtar5+vO18b198cthwCUKx4Hvk+8ht5K3njHQSOAgEwlsR
b3fys7zWdw415slRI4/1Mo8Ba+4Sb7mBjlLv4IGPPoSLyI/tHHMsisj/6ZbESYEBrvhokB0c7fRu
VhcL6qmASXHaQjlFVI9Q9JNo3Xc2rG8N19827FnEAjOCidhlLvO8kRqv1lT0JAggsyrjyKIXyCKt
8tH73xplb+qA3y7IqjNXyfGCLOXNbY4s/RdlAecMGsjrx4/uvSKuOA6T3y4x6VafHGF6O6koIlYm
CW51meRbMr3674MjEf4Nqgibsu+A5pROOBT1/P2Ti79T5niTWf12cR3NsqNR9NwpY3qIbUMPFpXg
/cG7HIhYV4RA2IDzSa/yBQvaWdFO+vnUThiirbwKzb7QtrmuXj7+Oe+93pOaxbwKOFZqcnb6VLNi
x8rZdmvVX3lpUu+Q0RZBpKfjNmZ/98kV3/kWT5lE7DiG3BE5vhItyx8FtqrQhGN1SJnrz5APzP/b
ODJP7mzMDc2bIyve28jBg7pIPPb7CwlqI2eejx8eTtq/LeGa5p8DacRqmEDGy/c4272wnotl2/Cd
B6TfxK/MK5lfZ+uEy69dN3UVxd9Ahna7bIYkJsS6HArBdjMCdLZbJwzqZe9Fl1E8pluOTbjDYu+m
JtL6Nh/q18720u3HP/u94vspoCOpwRiNBZVnAtqGzYQ+KyhVPm3/YQhdCTDrTOd1BkZ+USyWvfdS
isQi1S0+Cde7MQ1vvkKq0wVDZHn3VmLbvug945MZ5516zdvD/u0DMWr4F0JMcmcPVrVJClFccoZS
IdzF/PbjJ/DeJU7Wg7UgCq5rpLsj2JEqo+dcFzN5cB15S59UhN67wslK0BNSYWo0SXeOq30ZMtO8
yQrynh1A5J8U0N75jk4psXAvCnrDjG+ZElIzQS4hEK02trif650xksD58bN6Z007halHnWn1TTJr
uzhPnijWkAY8YVkokx9k7S1nuTPIT8R1b8Xkv+mIvI3X39680xWkmSRZsif1UAQt2M0b6XXqmo6q
469H5KHpjIjc+6y6xGtpBnUXGxuRJHMILXB8JE/qVzl17NPTIb9Q0Ww8ZuVk4mUzJ4Bri9y4MXJf
q9YWlkjwMVgrnI0oUufGHEirTiWaAof+C7qsSp5NGgnLw2KVG41uOzmtCy4YTxTX8WqkO1M2+WUk
HbQCI8GZSmvmTSL18qwscmQQBQwZto3rppqycpPjeAnlMemNisuAaq5fPhlo73Vc33z7vz00AiEy
hGKFtmudqj8zOFttmIiSELNuH1qRlYGPWTCU57l26NNBv0sMg0OImySfDJCTnN9/1/ROId65iFvR
RWW0U1PvmcfYvuKabrjZ+R2mrJ00nFaEECY8A01d378ooUrEX864c+tGcWpeciMkk9W+8jL6MJ/8
rHfW2bdf+9tzMZO4HyxtSvZd0Rq7KmUzgWJR/GPq/z/AxW/sKWh5v00VRyTWH8yq+7FLK+hVv5Mt
3v6Tf6EtzL88wLSmPNKzddgLvKF/8arcv3QJ9d0jbEKSEnFURf0TbeEAtjjyLlw2YrCp7N94VcZf
Ls5ILBIQMWwpyAn7L7gWVCL+WLzBVcGXw4ZsoQSEliFPfR+xEJ1D3KmL140MG78Rq8SqLzI0tiSs
usnWNYqG4oYeUVJEqvm1dKr53I6jiSxo0i2ivUWO0SNF1opCY9pXBDlZxGgGBvWFLdaz4/8VTltt
Mhv2IjmCJSr4iW1c1bVGGpT2lD1n2opkpaSeZe5c2dPltmSpE1Uy2eX5Il3xYs0jSlRSn8vRN1eZ
kBAuiDsJOYAJcSzfHJtBGY4ov0rH5hpPkV4HS8NJcZPVc7erxqOtqE57IpEzQf2T/BxJ9NSqlVIG
hdtZ312lsNJN9QoiY3ScvDkjl5OzktKXosW0Xa35LefaFVpDbC/lBphlQTxvnXmT75oOR2C2WfJ1
ct3ksdKmad3q3VDOgZHM3q0Vz9EvaxzjL5E99V86s+Z2EJCZX7sxTu7ELGYMYMNYbkZTEDmr3mA3
4O2q66yi60W5Dg4XyqqSrFKB18M9a2I5v1A+z74i1HKe07RqxkBlyQyMEeJzC7M1S8ew8QizCPMj
i8c4Unm8dRI3LC7R3XRk9tTxWBxFTHnxUL5BffQ+HR+oaoH6gYznXrVvACBzcL2n9EgFKuCNdaEX
q3LXNDoKkOpIEIKMSIcFStd46MhPIKKG1CODwOh2nDeU+pz2EmcXSKL0DU/UezGoIsyo3b37BjCi
BF69RG9YI5EdtSsxeU0NMj7IR9kbBKl9AyK1b3Ck7A2URMUQaJKESIYd4w2mtBy5ShCdjl1UBUUB
4w3gpUxNNLzwdAFkcs0m/UlWYfpUvAGbliWFZLs6sQbH+A3q5LwBnqKiqh2/fwM/raYFBEp/A0Lx
HQGHijqgQ2H1Bo1ah9WW5wnORtefsRwmL5UxaukBNN78q3StWTtrNIkDL0NGUt7GBflaQNEL73Z5
g1YJUwBhs7TuaS5Qxh0Mq9CzM4dk0ftBjTW5eBYEZfEFfJvdfgfN4GTni1jVvdFMyv1aWbZJGT+l
0ECvi2V433ZadI83NSaVU6tMxHl49mo/LcBU3RE8VbIxn7SKpGTKDgDkElvEVyqiZe8T7hjjnuwL
7G+VkZnZxSSm6dKohRxDAvsgyvXxQGUHlz4qAq+J1+EmwkHpQG8Q+B4yvafsj95hBqbk1ImVB2mf
ZdV2aDO6/tWSGeOBYCkYWLpGfdjPy8oiLd2w4zjAf6Yu+ho2TNBMtt0GGiqjCqm6yHVeEbQxhGG2
ukWdPN5nHgzRzdFVNpxNXdE/9M0MTGAoB+ick2OZYebl2guevfzaS/Vs8GtK1xoPMzNfjqnMz1OD
vdOP53i6kpw6qVFFyfzQrF5aBnqLO5J6olw1v4kzpYWEFaPAbETbfOsA57X4qHrnG2pkSsutbS8v
7NSjJ12Y8U90pvUval0jYduZvVqUnpsl3dQDe3v2KZhX/N6TyQXYja47d80o/2HrZsXT47h0DbqF
eu0cEyZ21VpUpwEkrPCE6MW43+2KFhEZytIFe94XRXYWu+Z423oOolAvM1AN07QimqoEJ5v49dAJ
N9Bofj40M/v+TWmZ5/kAAz5UShJ9RwHKtnf9mhbUSdNj6NOSyP7MWwmO2tA0La9scMzdd1QmFBeX
OBHWxotdOfiJlFG5aa1cHqZ87CRNllppGya3AO6vSzN77bpntp78WdfqWi1Y9FlLN4s9XeJnBudG
OLi+n/FRYW5zKXsGIykoz7TJ1PNYQ8o9BgXOYF7bJf0eKW/EkJ/Z3uzXE3rSDeG9qgy8SpiNv2Tt
0u7crqMmDEKu/Sr6uv6pnGr9US2afo0gGCRan3UOxdlCWIz8uSeIHcwYnrlRgQb2Pdo0UPmMBvFC
kfbGL3uyabWNJSMxjHhdtwPu5Oe0iJYNQv5DISs38NqcSn+Slct2Woiy83uEfg/WkC6pP/aOdS/4
C9Ven7HoILCvx+/p6BC7lZea9z2diGHFnZoIyJApZzEfZz3f5uqUkeYvaeueCRUZlq+QAT+qQdpo
SDGMxyFnN3kZkeSNwborx3uhwZEl/NiKxx22jfLJibi/M+z4Hs6DZUh2+F5TWj7aBDlhkCqzqVGq
5IGQPP2rwqpIemLFNgCUIt3gWwtYs6+VS3MXV7iJ8JoaCSVT5discXXZEJJMOfGfARL/t5n8YzPJ
Efl9XNrNS/cSjy/Ln5tJ/pN/bSatv0jaZOtnCZZMh//9ezPpiL/AFTswNtnSOYDSqNL8i5NmeH8R
HGGxo7T++S//w0kT8q+3NFL+Ug9HF8KS/2Y/+eeBn9RaaGtQi01IaaQAQ2H9syTENswVE8jPjRkX
9xXcBt/h46OzHstPqk5/fyVHejp8dof9659XslTuGJqV5RsklMtVM+r2DWAZi9MfveDf3gFbHVI5
qt8Ra393KRPapXB4gjZ7hj8vRTjlOIiBm0LlfpNg1mRhsu/aLvrk5P9nLeMfD880UY5zfnAkz/DP
65CTB/aMqO5NPosesvPMZ1qJxDhHUoj3K0NA//GN/VnU+OcFbdfhcEJ2in1qKyd5k0gkzDNUArri
2qvdZ2gg3SVpldY2TzzNJxan/+yk7r65kf5T4OCyhODAHycTVjdINDkdJFHZt5rXm8kGIJG80WDT
/awIOkYahOLUpFl/r+ZmulqOJQtz6Js9B5PiMGOYvYrkaIc2+bGh3eTlV89I+21Gv/2gpO7crAmO
RKuEKpIsY3fmsTHZG7Ej7zPazX5tzCDL+76IgrWkqOeXNX0C8iHdgzPX+TdSWfE1iIREIwC+dR8Q
3jmEsM+j0l+K2XiKoJihCMjlN2B+5S4BW2L5/dRr166iPRTpkfVs8epS/HcY7coux6o0jMNywVI5
vMi6+JHkKgs4LF6pXkJxEZ4KsMt6qHzNIeN5SEnHy6ZSQIPxnAUNVpCB2hlfqfaVzHL3ypbttDFK
cGqOM7bpUTIxP1ZsSnewUNPrfHKFXzQO2Y8IMfZg2F/0uhV7RApHZo7q40fdqY2XjgLxfcM5Bq7D
DMQH9OnyCiW5Zrc4ucV2tSciNi2wGn5RKhVqzkjj2EtBIgQFG5RrO9PbgZ7jXNAy8PQggtRykRQk
mVMQ0vOQFa57QryS37GfnR5k0hhn7kLyp9DYybEZF9+dlWhStBAVYTZxSqBClGoXJE+68PmIqO8m
d3yNCdr04QwbD5rZHPtWdWSnwTKU2YVTo/RSZRGddfQIN2LFvRZ1Xn9IkDJdZ0UX3xB7HJ0Z8OqV
b/AP92NJLm5AlaUIu3qxtzl6b4cK9BwFaSHUAbDucL+UduuARa0mw4frKw9DZiffYsN0DH91OQWv
qnAQ7uewW1fdPJBsVr2IuIcfWw+ZeGXJZv+Wl/24nyK0wH6CNcQvROfujTTNMp+m6rLhJGiExNmq
nV6n12kvVzpY6/jjSD48lLOHPkx3JkSHptkZd4M+dD9HXe/Psyh2UCPycFcbsm7ary1kfjAeyq9a
9l6NyGjRF0P71DoqPiOJx0SCATd19LREhuaINAxgfIVSLF1Dc1ETyBnDfhwmVd/Q+kUsE1d5ENVN
9NUdyBtkOwrExir1A0XP/NGmg0MsQFs8LxryvbaWDfU89+dAfsN2qFL5ZNSOEdrOsDykXhnfVcp2
INVa3peIUgDQZ8fdsfGLDx7ks0v0Te4Mbc/Qv5hrol+PZhNdGUbq4oVfq/k+IQcgpBsb/UjBqV8T
+EhG9iLzcy+d81soiv0TJzo5gKJp2mKj8TP6Vy2xmmQjFq/M9kO16PV2qhRpb8eQg0Gxwz3albu8
N9sdzfW2hW/izOWt0kWWhC1AZ/1H5RVTsTWVGqMdvHe32kU2WAff9My6vkw4He9zs/eyL3lumoYf
L4X+o2ePKreLPsXLJk4NIsRaF/jMJUsKz3uN59wNomWwntdWc4ZwptIit5jWxoGUONKoD07aSPKT
Y/dGh0opM92wd+xWOZF1EAemcPXA4OwrIE7lC6qB8SFVtUVmD3sxubEtYV0CKwP0TNeinA6JPUX1
ocL9/ZVNnKV2hmPOL6UStoPyqud41Yp+fh11ii/0pXvzERquJw85udC/yqZf7o2lTMyHLI+oGnPI
hxsuS7EmZ52m5VZYyhJqYJLBEQrZERR3iN9cX0ujL4Aoup1Ov45qsqURND5c2Lg30UXUUJB7Ig3H
ocMZpaKYZCIJxbqeDjGlphbNVWDgPn00ibVFlp5lv6xkWQPVJABLWw9OJ8Np5g82ZMZauJJ2nCUP
HeeHgB6sfq6NDvMFz+NMU9pPmArqorW05maguBXoBYnPQW2LPcoCJBuLus8ZXvWgA/bHHKBzvZ0x
swUfEu+hH/trKA77qCrdhmu5+rZs+10TOwch5zZ0K3jhVWQZ13glH8fjM1qTHSsQZNHuXA7TuZNo
Z2Ujz4u5eJym9smu23Q3R8ur3RovJkFo2WARvaIuDKf54uqJ+sI6tGsXZ687cXHmdLRnETZAIp+A
20QCGHgcj2d1Ve9W2sO+ctbHfOGzAZ50PBSsL0XaXdR5fskquRu87hcK111tWteW1YRl0dzXbXFb
mV7lk/Kwmxxzl1JJex6ZG/wyOVYaJJ1mJFI+cY/WlaqiX4k1PQC9upYGg4TIzUbALpSi29SJ97UD
ThZ40VJjf4vKbdz3t27DOFLrXpJpkhTtLlpaimxZ8jrrCCzHxY+9n2OD3Ka1PbJnikfOpoNf2Iop
s+AYkgNcwnwMSam6sO35W+rIvWnZwZEvb9bMu7mxKbIS+cnw0il+8WpcJPlyDcrk0CV96yPcZL/Z
rPyJdtt3E45AeT30E1Au3bmKa8G6b46XtuWKe0t2GxKgdq2aH8p4ygng7urL1o32lMIYR6LcA+7Y
Lg0ILFks38AuNUjOisM0DRsrdRHcGYzhqNZEMNENpXioWbtxbuswnjWoexQiAmOi51mT0SylDZnM
64LaLTRfSLGrkUX72dLdaAmHVsNVbtCYVnc9QpEzlYUtJZrN+qJYR3JkWqvY4pc5WIhQw6xNBvgx
xUNqszXU8+rS6bR4lxfVdlzTM311z+0+eSnqnKgSvb1LrHizSMholhCHjFKROupsMRTde6V7vrSx
eZ1pWYWTFYclF+Dms2ojowU/nqlv5UAsuDa7X5do+Wk1NRsU2xmDsT7qRZOxCNZ+wpk0GPJWyKy5
ot4C0h3ZgK/r3VXTwHCcPW28hUXjnXm1/cTpm0fWL+eezKKtQ45wu5b6jnSC4U51Y7St6xaOshbt
vVVML4I8rstWrvJAs+kmSqv9okdjYHVivcw1+6x1tXqfEpzUwRxBmqo9m6z1e5rdyi9d45IT9G01
A6ztsL77JFjB9dNdVL7NFZ3x/gnFhRlQRcJW3YvdEk1w3Po8HMb0ifZov+1mmn9IPPkzCHxnd77t
VfpYG9MdBb5zb+qRhYk6YXBHu2YS4sqQ2iUCRlhmDmW1ekju50W/MkyCvcrm1jOXw5j2Fwp6HPw0
BxKBl1TTrq3dS9pH68bV0Ua18bljdft6nq7r1q62y0jggU2FajF+5em0l2Z71ybRI2X6O9M2r+K8
u5BFcpN7o9qqddwYy3oU0iJGTpf5lbT6cEGGZ+XumTd0+34CV39MIuJzxRGCOafPL+skviqyPNu6
bnpVK+O7OZfhOqboDDO0nNCLfENznw2rvYsXcmNpXFxTOt4QybGl1kHURJEjnCpDItC1C0evHoZV
/458QverQoWJNqfhEU3CkJ2SQ28ifeu48dj1ciiJMzXDAuRFMo0YhngurEvrBULFizXjW8dtylxY
U7hJU9u8k+0AIoyyuWuNxn7IqeDOHSEYTQMHY2hG6XuN+KL1xlmF3HKjd6v0S10tZ94EJF7rxA/d
5SXmR1m1Rs6FkWuvTWHpWygbzgEAh86k2H8pauu+SkYN3xKxhmIC79cTrZTA8+/SW7s7KiVp1/h0
UtYgr5EFjq56VXEdBZVqLkdn0g4poTko249DxXvqi+p57qpQ9tl6Tzg7TRezozUqWZxAGrTbZsLC
hATnq00uHn/l9A353mVZsN5Ih06qgXQR5kJv7K0VTNcw99kPoeR3MRS7pdfOl65+iWh7bmZk4kxT
G8vh8RYxgX2NQ9mmdYx1myVU7TsXsWMbq3taKSwujXPG/XMrTnWVpc3PYu7PXT3CVuAchbuks1PN
Jate0Aw/n0E4X+qZJ3277DV/EEV/HqkemPNAyRvG5bFObtTV3snyalevTqaHld5k7FnjNjRatMxm
vfws17EJc/QUKJHGI22yqehJt+1uoA1eUWjOQJb0/5+981puHUnW9Qtt7IApuFsQNCIpR3ndIKRe
Erz3ePrzYe19zkiUQgz19YmZiJ6emV7FKmRVZWX+Rh7u4ekO29oHMot8a3yL+txFjfYcLeoqvZla
OP9TIaGlG3jqPgUzwjurMdp7OTMV6m3kxzISy68ZBVF/oaaBsky13LpBiYAMwOfNN+9Fos6nEE2N
JX9TUHvfS0Wo31Ovtt9N8N/rptdgrBsp2L8RuXf8+eLGXlqzbILfJcEhsFTjJZaTYVMJ7RyNq2DV
y1Z8AZ4lfMM0xWxcza5xPDBsaUHNH0UyhbR60fhejKdnaZ9lVjDApK7l8SxslZLmxaAC1KBTXzu+
kqp7PFeiLVod4UL0ZelmaOVceZbRrYxeHy6qOG9umqbWL3GJSc+r2H5Caitb0PkWb16C6iKM7Ibn
jeEbCz8mRnO7yfcVp+BaNPmslhAbN9WYRUsZ6a6LJpMo+anJsPLKqnQLGi5AovTuMguFcT92NcYr
Imh5RI1FfW6ga7urgZG1NDtq77qwfZyjYTUtNC9kOyGM+BCOgbqjNaRcUxwAgG4HWnwONSG8lfyY
9NeT5b5cxLoXr4hY8x+hSDko89x6GIjCd9Nsq2UX9errYGvJXo6nYgGsqNgFaRVS/UX5qXXAatcB
cd2noJ7Y+1vg/v4aeJe5KYXXnOsehg9JKL+1dWmufNT9gAoE1m00DNplaSvlTT+pkjvWPelZqpwF
+oTveGf96SrFW4L2NLf1ZPOhBxWrDLnIRxqiU3uo9HSuapjRUK7BH5eZO8xfakvNVup9NlhA1gRT
UyZux72cqpqw3jMQp1a+tHTC4coM1HFsz2VRhkrvljQVIzD7DQr9jTOivKktyzEGl5H02Noswf0m
YKkHSTmvMe0WV0ZsKQ+NSEfh4IarUToWuX9IxbgHK8PhmvZYuwd+BxcKVdI1nTwaSKOu8dgK/YXw
ehQYTCNfGvx6EtFAW2XY1KwUJSn3haXivhFatYuSh7zMx7JdwpsZlwpquesWeaKVYhv9pmtl0pOp
W1baiN5VoLk5Tp8rGj0mJZhIoImrNS51Qms/2/c5ovWuyp5sSQHjDkfLHtY5Fz9CJJE6C9/yueKi
WzPVYRtjo7TmyX+D/wtyqn5vnXkjhMauKZdR0/vnUT08CWt6M0IomqOEIEWnNdIS0VltGxTeWlTT
waJlEeO0uPURz4NBSNMJJ8/GxR1IXw0DuPYOLc0tNg/VedFY/bpNpmQXjCIBpUcjURo17dGzgYix
n9e+rCN6IIfZKk+MdomO3gjYTdx6KknwqNerNoxsXhQq7bhisIMF8Hlj12Avu9B1qTuvUrNYedDW
zppcR8Yz9VTuymmQLugFG1iYYDORS64JucHR9ekVfUkij5bgAv1cYzUqACSxlGrTRRoY17oQu0of
jaUFu4vfg8nAaKtuRRyVTm7nuVtYGD+GublnKw9cmCZUpRijbTUOxGVVFBdDiGRaYMjNyheDvS3t
XhkdiljRQ52nKOfWhd+fIbP8WuS14RpJEyOtr3TL2orz9TDiRSVqH/FVWUuh1dQvmLtnK9DroBBD
S1oFnh+eBZNVXpZ5e6AHa7hm5d9jue075tjHy6ocn7EjEk4hdzSsYCZt2O/YtwwYjqtY2Dp2J69y
LJ+dLlO0xzHNypU34/EG6gROb2kXlDpH+tZJ7fKqTF2eGO1OB3q0wKZYIiWiXbdSVeHkZByLVCEw
fTn2nArjBwfzRW/HQ+1FVuP3CkGUwOJohpyfXETDaJ2HtncJu5vnRKV2T5qNHag9BkPi5J32Dq0R
fa5Zx/UOueCW2pl/XTRyuLcklHnjSbNXnQzCC9iH/KRwMJ8VsVy5yOia5xzx0UIvrXrDMyZZchG0
NITMBLW+UF2OlanjO6DPdHVleJwory5rwxr31MHTy2joRx46UfYqeV5/LSjNA3Ow9QgF6CxeFpbi
nXlMfkmTdFqWaiN6RHX5L1tsfLaqjOa9XAGOsgsdS8GxksqFn0rynVW2XJaSZizDNGtvMtRgdrzF
i2VeQTv0JXQukYQpz6M+s89gRCsQiqaIwmaExCocDbuAVZRa3oWEbTbA//J+bOPpbPRibdEhobXQ
tQr2i6qmdPqTFxUiz4LrgniDLjEJ7ULBcO8SNUuZc8kmKzPLLJrd0ACYufFom/cqeuq4H6r+erAr
aYsDHAwRdM0oQuR3cUGZfULIxssDc+FFuSBZlKRF7wnVHQfNchR9eiQcok1dTTNTJFJ9J4JB7qgd
KWjA9nD0jkgRJMq18pwKdCa1RqHorAEJYD9dGUOHto2VWqs2pl4f4bq2sK3CuEL4Jb0QlXYB0D+p
nQmmnUsjGgHyPLxrEuVOQTKZ0mfAQz7Xyf/GUne8rOKUICSsCpctDS8zrTHuS9SGHQTUSGGmFcru
MFayM5vWuBiKJzOyNpGnXWmj9QzB9pVUSifFxTkC1HRzGYjhjygmsYpEnS49YfLsqOvXwO8BxeFl
gcYuj7xSbs6Uqtev2HPV+ZTHzb7iit+kkVK7BeSETVD6wxIf8Xjlh6YkX6EsHW+xqTvXw/FBK8cX
KSpbXmz9eJNNcn0QPQWOEqPOcYFZFDjDRr0s2pQ0E/Vmy4GDA6E17Het2varTM/sB68eMYrWCt5R
miWdIw9x3iahcMyC5qlvIa+MWPKN0Vn3pm3swB8kqwRKWxLr3HCVbyD/Wz5lxli6qtevi27Ymihs
kDS4FHT3I37Lz+XIPRoHsst7atOZ7U1fhctmsLBznA5GgY0XFfiVHlEKCeX8HFlvldwX2LkeNVC5
wvC6r2qXAriL7Leb68RihH0FXqhn5qBfmCFe65W8i3p9UQgVwkO09Uuxsab0dhCytQIYswBQvmlz
zks7vK6l9rYLirsqaxdVbm2oqa4CpPtayiF22m39OnSTwFj1nvLW0CCoUbgcjfoqkyb9WVXRaAOM
mihctiiVu2opLXO/Wtb5OD1EZrqZOoj4gY7G/ew0h0R6IiFszu7N7J1mKqvU6xDu7ixYc8Ps5nxl
2drK1tP7AlWuIKyeUOaF18PTeH7aTP4WeiSArQJRUxR8pLF56lIQ8zEUdgSeikrFwVZW7e1oG3ce
YCRc1peJaImiyQUFjiheQUKLKq1J5d9Qud/AXs3kR8dP/6RaUV4MqV1vejV3uTW2YE+Kx17Ttimq
dUHXn4mAWz30hjPf19wgh84ukCWnuLtv8mzNw5RY9bR9BkGLggHe9vWi45fGfv5URJXrR0A17NBN
s+KKbuijKXEMWj6XtmzsUz07ZDUFJFsGx4JQhgPbH3NXha6AwsdoF5Fp7AezXgcGUiVtcqVpBSxE
7PeSgL5RY60kO872LOW5rXu3TVORZfyj9eq+DsMVBL0r0Ysdpq2xWwNXMbzkarSA2UwDfwjVZx47
ttrBwfb3PmJVKNanN/D8zpOR6hc3utao7lSms+KVDHOp1679AF2WyX6GdQoBCpoClwf1UWkzqNFS
0yYV9tGwj6v6vLYKzgvrXGqLHbYaLt6TS0zkzzKPZ3/LHrMHGn9O0WPNxC1/XST+Xuui575ur0Yf
p99QbbZqNC0CRbcOFNZH0oDEzb22WRq6cY6gIRRXaS5goiSY5d1wjY83ZW0AA1jaRVdc+NeJ0ZxX
pJSTHFNAUCmtMfu4g0Sp280OTvEBTe3WqcxuVyQ1tFMKsah4r0O07wqh7Ia0zRZ1j4QxZacr5Cz2
AkmtheH3h04fb4LEc81IxXkAmnem1f2y1arEaWxOU08CaRGgsbFqQnkTBpB1NeKKt+3SiMSzZnnY
L8TtUy7a+wp/87WUQJOIa3Mn1NEEi1b9kfuW26V9H4LhrOqjM5Hb7pCFT11gXtMxulP1zKLy3j4n
WrebYss+oxdxKzi1CnqD9DgB2gevYzdugw5ia2RcjXa08S2P45JmjxLagVt59spUqkOvU1RQextB
+XDYlUI50+N0Nn+8sybpEt96ePzS5IPFEjdtmNULDwqc8JPzvkvfIpSlh1JdF4N0aRvBiw0iC//p
8MwTPPzmp1zO1Hspv+Rt4mpyvNOTYOfZwyE2ykOLAfAi0OttVtQX3H/PeYimsaFYd4kfDOtUbcif
TDTn6QriiJhdmlW8ryDzrT1peqCD7fTpsIMGeQnzeuJd4cl7iOHhjeLzDpeworiYJrpyvZXj8Td2
anszheltHPXDIsAhYhlj5zvCqat4dmHveWbaUFcUOR73vSKDBrKni6JCC86q2Rfsj+SsHktz7Q/C
goSqFZumNJW7ce4L4nVDhV6xoJqbaoPlxgDyR20zCj5WhXprTzr7KKG9OBF09rQLZU05Bw/VLOKm
TspVjlz8UqmqOQWyjBWNZJrIZTK7niTBTYoW+2usqdFVMpZUfWJ7LNG99GS3DUP10I2hfqWZAeTV
MbR9pMFj+a3rbCoxUAhaDiIvjBa+h5BlKQevSTB41cYLsceDNeO3T1JfYoAt+ry/wlWg6GEAWy2X
FZYOqN2Hr4iRoMOfZtV1Sfdwk8eqeaOF9vSATyjiKFj8XEh2qQDaTXgx2yFG53UnZOybkuGK0qH2
5EmB/NxTSd6AqAJXpcMLgVAve4uINlyyDH08Y4DXpSvPDPtDyZdZzqayS6+oSapU7rCs9sMXuzQh
GdRTC6q9GRZ01TXycWSmjagBKdwO2op2Aijg3LMPMMzR7Jdr3o0JyUXoNJKqrRSqJBzsXX8uOhWi
+KgbfCO8S++TzBtQxOjMbaf31kuAGOIKzNpw68etcCwLZkwvkuEOC3BQjYDvfABkbj4Cn3KangsA
t9JiU6tZu7VmxYs+rP9g/vlsNnpzGVI9WCp9XN62qZBbR+R1h25/nJ+NUxvfVDqF1aIPKcpQV3Wn
SlEWZq5ni5hWigzQkJVIfJqSFFB1c3rN6A0i6WDb/dkg1cm6qBvOH3kyV6ZVFrsyrzI2EEdb6cuu
yJWLnJr7aqDsdrDlKd6Fjb4GmHBNa0g7BOlEHozCcb2UQfW4g5Vly45s+2GoBzSIoFEv1brJkOfQ
uf91P6GgHo7dsqGE6qoapaZOo9hQAhU+93JTukA6Hkir2QFkdHQU+rhBu+RSHXtaZpnwd6Iaeu6O
3ptvExAXDozx9iKsNQ3JPiXaeYGIruXcfC4rtVxR/6lXfmwka3IneyGZegoBO+dibxHAvpA7Mw+J
gJpmU4xg6RYuu31jNzG04rrN6z+T4iGr4bdVuirNvr20CjnluWYgxtBOarvuensi6Sd944lvivUk
6qohLQDE51QBUFi0azVx7lWD2NYQW7YiLhK4xOWEvLwRFHG3SvFP22Av0c1w5cgj91crcQvCTy1c
fdCmBR1DKgCNP9mX2BvDwC9GaSRjbMaLIUZaYQQN+6jUSrqJuzDAuK5H96Jp9POQRh1/pmRcFF5t
ujpa/6zpmKLAHeWq819TBmKnaBVKCbY6gjK1fFn1OK89nhJ54imPthEZwaOG9bCPlwqdLdc0Zl2E
/2oCpVRKWpFLvwNgRXsDBRp6Y00pXxilWTfr/4oxH8cUjUJFEWGY6QQhYy1GYnxYIN8Z3PseRjD/
Q5f7/+i8D+g8bGk+AKi+UD3u37K3qX1LoHr+x5r87z/zf+F59n9bsmFo1DuQoEBI5D9cD1ObbUyF
JmyAVrr11+H0f+F5iv7fhkm5AWdyASyKmt//Q+fJYPosg3/GlvmHDFxMzd+g8/6ya/+DvNJ1Q4cr
YaiAA3WYJ2RmnxFmcpa0qZSPnnt/OTmp8+c5dK5C59J3LgLn4uptfbd9f/yzvfmwSN/A58QRxeTL
qEdQvQmzPz1F1cx9Lp3769y5BYnkPPI3r297on/++7f18unh5WJ3f7F/uXu/udv9ue6dU7+Dyf00
+ZkE/IESRbl1kKaYyeOvocivVXCCTml/xu99Xd0j8KM6iEbV53nmzuP9Nf6mzvP94/3u9Y1jyXnk
38+pMzm3r5eHs8vn2zPfOTs4V2eHw9n+4nDYLy6W+/XhbH04bOf/tNxul7vnm4v9YnuzXTzdXCxu
bnaX14vt++7mYnvt7nbvJ37/Xz3EHxboGOdoGRzuUsvvP38+f7zebs6fL593j4/r9e3u/NF3lvvD
frne7peHw+XhcnU5/8Tt9c317mZ5sd38HDN/vfh++i1wsD5+rJzydFGTTbGWr3PYsJavr7dvV75z
m7Oak3N4uw1ZS54m/EfYDc5h/Xb7xvLeDnM0P/D/fCicq6fAeX95unj/8/RyHTjbl2ui6+nqnei6
vnm/f/+TO5Tlicr3+5IN8Xi93z+9/Nm93wTO9Z8T6/tX3eunOYHQ/TgnETeorYPKcd3Vubs5d+e/
rhxnebZarRfOwlku+Btn425OQGVnG+SfIt/QPg8MC2pIeDZ7LjMkDK//vO9eL1Pm+3p4853DBWuV
Ofun7f3L1cvFiS8576qfJn0Eam16QUY2MmnJ2JTGQyg/+/EVKvVzh9bJ5fuf4+bI8PV/9qBhWoYJ
ElnRrGNyt2HJIU2GyKM66LutdVvhtxn2+zTpNoH66g+mU5rpstfi52l4CSVtmXUH0T0Igeiw2ErT
yxjf9WSX7W1kqiecXb89fim96sJULRCw9lFQI+WUySYNSoL69hWCrHMIndfXq5f91cvT1cWfG9m5
/3NqVx/JPPzvinwY9CjqpqAqaQ8yaC3TpdUfMAuA5rAbxhvL9p0Kw/vM2inNCSzzZ8w0owIqxs3b
VjRlvtmOrUJGSW2xkysnNy/92jWVcKpwOO19d2y66Z+fP/rxWKZJc2xGTHNVqsI65rpWXd9UeQNu
FNGp7rzuR+2lE716qKIwvfoXQxkKQHvud/2LhWiOW7Nsd5HlJmUz3eiT30SLUSLNN5Ipvft5rHln
fNw587R0WWUhbctSyRk+71ozb7NWVKbp0pjVL+1a95aIaSYngvK7UQy2iyFMjfxCPjobugpsiwYx
lOy2RVe+N811BlDyxBH0JQrnyRgWGZCYWQvysQxfgV86QH3VdNV6MFaB0LSHHu9xbZHpprcN00ot
nNxrIreMLUDCkGn/iTLy6hNQ/m9nC6vWAoJOF//4JDTbAMZSTkkH0KPhBjb13b6emsUvv5wl6wDb
yfJU2TAN+yjhqfUApV2v1Vx06MN1bE1wuGCbrX87igCMoQLftzDGtZSjje1T4u8DwwTvVMoyQMoM
3EBg/84yRSdhFELhuWgBLTFt7VgAwajpBetzER08tL0NSsVetI0WuIofnqLQ/9W2+BTxR2MdJVA2
CgapYjHWWEUoasWgq8xFWTebtvXOIrNeJlL6kFsNQHZzgX7ThjhbSqWxUoZ2o9B7pke81IfpRTOE
a8oqXZpuoNKn3A3RLw8CAJI2OhzcMrBuSPWPFj9Q7H5+57YujhM1QJA8H64jgbAVElJe3S1//tRf
Trh5YaC56DbJNIjEo4WRFU8D8sDCaFmUrxpLe9Qs+kZhBIzo55G+bJB5JEFgMTHZ5sny+dCJGytN
tBxGqYfh0HmsC3kv6Zp5YoMcZ8pzULE1eIUwF3gt86/4kIrnHr31oRSDG1qdSQk27FdJ36kXxghU
v0DI9eznWX2JLIhNPKxktIx4+OiqODrlwkaCRqRUo6vs0du8bO+z8+rR/iPodjvNA6qn9+PVdBG8
TO/hlb31lpV7SrT4S2Zy/BOO5twPGEEkPT8hv9du5IN5KS7yd2Ptb7XrntLVlUW7906+iij6nNUb
7VK7FSeO+uNVP/4FRxdKF2hAdWbKtF9GMMnRUfbFStX7bQ4K5ucFPw4jtoemQc6ykTAgz5GPAlaK
9EJu6qZ3cRmSHMWaqpvKz+THE6N8Mwydco4EjUjlXjlaU7/QPAXc8+iKID2jxta7Y6c8WvQ/EMKD
EVFRco4BftxpSr8eYOu09p2ZgsosMH+Eje6Y4GTt8nHqV60eYrW1S6p+k4raTaVzFbixMpuqgYbV
ohcb9OyIQFb/pChPA7LmXnGm4Pw2yX9UPqAsPZhwrRGEWZrUsuPwT94Uz9zXK50G2S+vMZbXUBCB
NsiuLNM6Jm7lEabWGHD3bppP9usQ++I5T5MTh843i0sGJzSd0181YW193qSRYkB7ozzoijGV0bbt
rkEbDScslr4fhOwATpkxlzg+DwKmo6olUfcuQIXRsVGRcJLGiv7FVFgvZS6kKJRojhJvJMh1z1Sj
HqBhre11U2DdiJj4iVNmPhs/Xl98FUuhqoKKhqpRfZz334dTDcCooQRl17tDHM+KmwkFTy1CEBFi
zzqH4rSIZyfwn/fA8fvq76AmQCmON/bAse2Y52NLCbS/d7vayrdmVb2UcKJDrJ4loC5ACvE1h6zk
Jnj2/j4KLcUkx0fQiwz876H7Yb66lkpZGmesqq4BlkZ2wKWYrG5+nuB3EcJZAnuVSc7PpqNVRb5H
nioJs9vUN1eRnrRbhTv+hNyWcnw4zuso5hocbzPA//bR4SglSLLnddq7kVA1wMqFvsAq07/q+tHa
xt6sBx4P6QpjbJX/i4YNYZ/XTzgobESHdp0Ye9OJkvS26HHPEsoJGbe/ydxxbEHu5TXAewDBz6PY
8tWWijS3patotU/jp6myV31QissqzOezKPYOBrrMm4lHMa95xa+v64G++UI28PxeSJOa/fPzd5kX
5OgXoVmjcxKRS/Orjo542qQGuCJY+VTvAYqMGlAZ+l2rBN/GE9t3/qM+D8XJYMKKtflC5O1H21cv
LL9QRNe6XWgBzcGXxWnCEfafUWQLsHPhftJkvCbUQyHLw4lc5cs8FVm2ZnKswV/mQP8cfzCVKguS
VOniAoG3qCkweVrQpE6Qtke+Wzkx1y9xSJyryETI8IyRgj2+0mTonloyygCMo/IykZrHQutxRzfH
Zxr3p8yevxweimIquirb0LU5svSjbE+S0gzIvBm7XmQ2S3kEj5i1U3tmNHV3qAG8c8H0yRrZbWv1
c/R8OSv/jjxnJCwvW+9o5ESCpFDVduwaowkaVSr2VVtgUF8Ez5DdNtnsVv/ziF/OEUYkhTYV1ebM
gjH++TuGWj1QXjc4qMoKbz2Up+lO56ccQo4+nzG/1w0uZTaFxr/+ZoEfzsQUvhAmWVMxi+/o2j61
wqQ+IOUxaLNoN1yjPBjiU56TRyHKoAizEDHzmBZiU0dbMdMRrbCaCo21oqj/CYFkrpGSpIEFaVd7
+dUyzmPp+PBQjuCuQaHqaKyOZ4GnxbAQmiZUrr2o8G7DCQmd348C+VtoqkEKQgHk88fyppH+GaQt
V4NvvZ6UIHqpNC04cXd+WTfiwZZt7ntTVzjFjrZ2OJS+kU+sG/0zAHypVmcPgCGLZNVWZX0i+z5+
AFD0kKkFcJERZTJTOgrAka5mUnYQo0LYMtaZWQgqIZmvAfNAKjwR1zKQAbuFxztOxmWBlffTVCAD
BVWuHaMlAoqggtQQUNtzilbgK3j5LHqzMjSdEJ7K+mUAGQCZbIF5Y+QOkALqHZ4KNYK4+IJd//ID
kXajUGCSdVOjUuSjvE2q27aqAs+CZBGgETZR4vCUuHd/HuXolECdiVFmGQm0yahPHaeg2NGXuYRs
xQIFp+ygAoB4LiWre1LAScxsqxFNSVUYtz+POn+ID9fN3w9l0R4j/miWKccpVQnwBh8KPpQ2RTba
qTDU0yj3TuQ1X04KjWOXF7ZK0sah9CUnHe2yQ48LfwW7VGFkiAZHMwA8krVo5FJ6Vigs6L/LtpmZ
gtycPatmsKJfZtawdqhVZalLubFc9hFq2SAB8hObV9G+LCBpsMLUkAKhlnAszhmDb0GwB+5HOYDS
BsnsX/RWBDGsK6et0lvFTYlrwcIPQn9Vt0OwbKx6cBTIXGuzrP0NRGfl4bffdM7MeWIIQ+W6sY6y
yNRqRJhGgMFt2LibMNL7VSRV2omZf40cRiFHVXg1cXer88J8OP2Bk4dpWjJKVOnhDSKTwVUfART+
/Vw4GufSCT4npESfR5Fq0ORaJZBoDlVQS63UrkFOZ/8iVsh2VBV5QEMlN/48ShzkupQUdkJO38EH
HHrVxXFs/DdzYSaUtRhI/1s3/rBiE+ofJTlrwnmlJO+5JvdL6GHojP28ZF8OEgIfYRXBl6HaxGP2
82TICbAhmIdJ6ly6RnoZBGU4QUNrgmZNzTE+M0OAVT8P+vV6YVBBakzVFJsh+WgFpxCrdEhciWtZ
+JUo8SBvRAz8fIqq9Pbnob4GHgcI+TG5HLMkyj/PL9b1WlftIXCpFPMMUzLo09GUxIX78zhfp0Qs
wNpXSOWFzqX5eRwYu0Kuc4rMGdCfx6LnyYFFRB2qxtLWG1V7+3m4r59NpTWBAp5G6RM+wNG0EqUy
alIRhstBgFWcEvpq7EcwRQXM+zUeJbD2+bTr3w5LuHBRz30eCvnyfHR/CMoI+psmjQkYZRlRjaWh
IDS4xqUHyGRbjWhncWZFrp+m1Ymq8tFDh/N5jlOiER0Jrr6/HfoPAw+V0jWDHEiclL23C3IzPYtN
H57uMI4LP0PkTEpi6aJUtMjFzqY/Me+vVxL1JBlEnE1BBvnRo0sd4Eo1gBHHp0aenSbxBwhmCU8l
QjQj1Sg/F6rVKSdCav6Gn29bBoUwa3Az8e4+lj22OryuheF5CxQ2pKXUxkBII0xIfv6kXwOXUVhf
VQHYqxJSnz+pHTURUv2qB+Opm/o9mq5UA5sANIwLnw7c9C+HI6NUZZNUnLFoTR5dN347CL0FrAtJ
c5Ihx0X3iSaLjVqiB/PLkYgTboG/T1Oi5ngkOpK2VrWo/MXekG0zAzpx3SkxRIXKX/081Ly5P30p
Mj02A9+IVxso46PdaCBXJCaBT1KgmhUkDHXoro02kcLRiWJN9s950YLUa6LGh3ipdQi4nEjYv8TK
DFvSFbITHsk2dd/PX1FuRv7UttMXqqbUjzUkmV3ZWFhZ/DzRU8PMx9KHbRiHnRZOUgXJ2s/6Q9+J
wkcBqk5PbLcvMTnPhmyBs5ROCNLAn4dppnrIowDhkIEnw7uW6tq5EYz2AShzeWJGX3Y2Q1HGVfQ5
iaZIeRT+fiuSgENMX0Cb9jBHkRPtuclxtveQ5zQcyWaL/7yG301uLqVRleejm+rRDkhqUdFWTPSF
1pM5SAVGWlAr0uY+Ly3x2zcps2O/6XTj+Jd6DGsbgZWnuQUpPojaYtvGUn6uivDU0/67GXE8CWKP
vIh79vPnisYuSyWKsCCc5bhcSkKy06VPSVxelDO6/cQCfv1kxDn6aNRXBepsf+3aPwRhKUxYCVkp
FolRLZU6a1e95SN6U4iDNiSnOgpzSH/e24ym8ZznGCJzN48CRKT4YOA6JhZ0ysTK7rTxDkOt8iAo
JJwZ0yg9aIVtHX4bIwyqzy98C5Vr+7iomfKux4rbFFx3Wgx1BWF4NGjVIrGW+iTl/okV/foB5yuA
PTev6/y0/PwBB1EB2CB9At9udLsoViFOZINyaaaI3P9+Zrz1KY0TKlS3jpbTj7UsSNB6WqSoSWGF
p5fiaSwlqFNlq0on8syvxxXz+jDY0bmshEUMt2MUC7/v+lWhZr0Do/T3pxWnkErnVgOVwp0zr+6H
eOSWHtVR7QSSqCas1KipTDzxTFjclaU3/2L9TG5sk4yWstZfqOWHwdCjBZrRsn6B5ukr0STyUg6F
tFdHYzpxCn+zz7S5dWhg9EHZ9bgDNXkjZPeIoRSzra+DSbNc7M5kBFqSEZm4LP31HTaX6mSKripy
Srp8tI6t3VVamNcCOnRj3nap7G9sM83dnwPwm5hgJ2s2expBzi93ixSorapUiVj0E6IP+yHwzXQd
ynivnLhZvh0ITUfSAirkXxoTtWIXeR/FAqMsEV1mUYKNTRtFvy43sWh0uQC80AuiiPY5+IaggQdu
Mp3URFQormHvKP10yh35u7mQV/DonTtNvKM+jyJXbY0ecSgWoqhrrN9MCy0lZCWkE9H9zWHLZyHo
OGtnpNDRxY/4u++jrScWGToDUaYpKx2fQtrVgL3qArG4VCndn+Nhjqqj850hNdLsuUos//XP+LCh
UMQo9X5kyAIZpKWEvaATCek2zJBM+f1IHOecFKjUziDMz4sYBB5WkZTiFz667OlqsPVRQkkJ0yln
wqTv6efRvvtkH0eb//cP8wIQOEEdE9pCl6ycLlQcQk/069W/GIXqxJylyTJ//TyKXBkY3Y1oRClJ
pK4Gusi7pIzqE/fTN3OZ4wH1XoJCxzvl8yhK1OhJ3EC3RWssWTZdL7b0xZQTG/ab845RwGTovIZQ
FD1KzDTJLxulmyXWbHU8E0qBRQAUmHtPy/XzoO6yE0jQb2fF247aN60JHg+fZ5UZsQG3dJ6VNCIW
ZfkB4h9D+vs7kOiGKqHTJTY142jrtjm6scDXiYMBZ+HOj1GSyazY/XUcCEDFNuA+nlVfulbREEWj
1xEHiGLAqpUk9QxD9eDEin2zVxmFlg6LRUp2jMMPqspE3xAZO5jd0Z0vR1a7rsYwCe4SlPylE1H3
XTx8HO3o+3CeTrXIMFSVGt/8w/1YLFsDCmZc1oCj1KzuTizifLodHUUzqoTKIsVYm3zrc0CorVmh
7saWLaxYcnFZM/ZZmvquHfX5Epq4DUEuHfLOraK+UX9/9AqBHhfD8jChu/B58Bi1XquMmK1Z9aaH
zq0fADXscy2EKa/o9YZKBQpYkllYp2Skv9sIIHYwdtEQXFbNo4UmoIImqlQNKwM9fR8adZiQTQp/
iaihZ8I1aVI24/SlP68fzRA5mwpPZeyhylGRXBqDnVtbnnYiar6dzIdRjj6ildpBjHuEtuCjtVuK
Hd4mtBBS+Xm/fbcTSDZB7AC3BJNxtGTIhlcSIBNQwhJWngt5qjE67emDvwG3ADD382jfXMsCuK4s
5iIDz7yjkzHsElMvfUaDHGjDXeRzORk8RPx1Mc2uDPuy62X/RFuQBsz8537aEBz2tIBMSGCU/JDF
/hyTDe8edYpxIbbysrktFMSaN40WNntA5RqyDoWODlim1tKTluXYwSHjBAJkLKxlKk2RuYptMgfH
zJvw4EdYxju1UIY9+msCimOlY0b7f9g7rx7JlTPB/hVhnnYfKNAbYGYeSKarLO+rXoiy9C5IBs2v
35PdF6PubE3X3plZI+xCwoWuuroyk0lGfPGZcwYjLm9ybNeGb6PDQSluw9Bek0xEJi1bM7mJiElh
jPd9vXcbpWAyk5HF1G9sG0T0oEz6nd5a3VPZZwtT6XHTyGDoa30dO0tEP3dvmm8gOeuzvDEXF9uM
g+q4cBneDs24yemLG5xeAv+p51smx7WdSA59vrUV1ydqpjofnuLB6SuNqN/kbZSdQhWJqWIbkRcH
SWdlFzRUl1UQt2OxFcqYx6u+Ve1XBIGt9IeBhgW/7/L6tGtE2zIR2SqgeIWjA1nNsvgJOSj7nBV3
fKZOzYz9bGP1ORmjwaUeK6WLcmTO6occLTvi3ywabilL5E8DfuXCLzn5534MtOx6qJtsZriETIZP
XTR9tPCALMyiYrZda8vUvceaUme+NXb5recWxryrqt4FlbpUV/TVA8UtU8W8lUadMslb9Ol+aGyn
xl3rSOG3HR3ERXyQK+gaFI5Aj3oYlmrTKpdWt2SPsUbRM+iT2sXPYTP4GjjZQS6hHLxjOBuU8Wzp
7LLdODDlGsYSjHHxxynOU0AMzbiF2Com301MY8SrnqRPs2YnT8BsAHCJbtKtnXIwcIQDXbgfHRMI
p2RkuWhzBxlVtdpJQGhb4lPQPxjkjMxxXzL8Mrqfx5wwgp4qCPtWlzqIrM2if3UwuQC1SnPzQYpZ
vIxzZ51B1rCfW/ornX0NTmhEweG0EGUGnFKlZ8PbUN2+u44jqGmBbkaYlfVuxjC3INbV/LppEdc6
syzdlewaY2elS0KMSR6Xjk7VIHEHC3MWgZG7xq4bmvI116fi0oNx/T4khfeQFIAIAvyP8z5uRPms
NWb3QD+Xcpcib3kj6weIPVpqNwtsSs/tynGkuktSkxyTnUpzXmH3NWn6NAZjCqpEqhc9XiU76DiP
3QIckBbWFq+/BBPaOAG5K/gBDON3FC4Su9gb3ECfCVPDUTjFSofqBFYz31ZuxDeSE9CtnL35EeTw
AFgUwR4wknkaG78w3X4MEgfloQ5MvVxTw4izdU0OCfmSTIAZseOO63lRug3hHQJliaGlIgmHEzcY
TXO5ZxSq3cfUNNCsGo35PjsSVqID9zjf2p5sV8KYrCgQJFFwfkD3BXgYC+9aSbxlOFEpaj5Q01ys
dSUN5QxNIThDoEz9jpNTtVejtIEzapNaTF23MNdd1Me7fGmzLKQhzYXRCZE0Xyv0mMvdqHO0Xy/d
Upx1jrQ+EI5N13ZbLTaD1FLovuASdL5Z9kIN4WsWt0qLXUuRpnmhj3iBIG+XEkM72h876IvUfV60
qT0vM55HUrZl7K3onKutdSm08kQa0+QETafM3io1dBYqw/mGe8a2JPy0Rr8capS0GLkhIcC1s6T1
SlpsBEmaLdM9m5DtbIZuBs8zaUo1rTVFtxYfftVUrSc3zy6Z9nbVcBws63bQwCOGjTEnnT/1Yjjv
lhJ7vDSRUgeN7sRmgJWwg5DCQ68FY7PQuTeWraaGbtuDkIbU9w4TwGUMHjPV09B13eViNPFVDYjr
Wacc9AlVs2XVmIqBOrBWFiE3To6oouhQhqVmVH2kKaEWVpylSC5alZksup7m+SY7iNmYwcviNwgH
5SfgU3cOJ8ImudXmBDnZlNgen7uX93o/dCexpegFzp4puzXbzn4hk9amazC74zk9qNpnNJXVhQJz
bFq581y/jC0PtT/knfHqgYSYtgO1j8bPx7x4Bgw9qrRYewduB8WfMDXwLZ30aTq8GTgbc79ZlOmV
jvlJXXtc7zMLKFfEpSu5a+2ladd2ySFnFU2C36nFCsRXV/HGfKOXqbxKski5ojdQeZnVZTw/tKg8
I/gF1NWXhnZfSbccaOdLB/pp7AUkzZROVOkTa6IXx1xaOt4KcHgnRlUObyQb+ttxGrjZbLeSNyrS
gLckMdgRphEesO8VWvsS23JmacxQbAcWnE625gocAUiipAqkCkAhoEoT3beL6lXqfqlS9uFN3+fl
laECz4an2BlV2ExFkwU56qpLYXb9uzSqaDdNffeWiDwqggFBOG41Ir/lG2/plo3NfoWhaQHO6bTp
PpZG9tQUdiPWBjtRFTgxwaYyCfvZK8CsgmxohPSNwWyIeA1FPmt5CgphUlR7xXMFc4E+2OI0d0Dz
IXkaNcCT9Si4Os7YuST/8vwuX1zWG69XUhCvjHxFvtqy8gV6Aj8HkokzYnzhnfpwM/NkbRWQVXm7
S9yejMkBc6ZOTbWEM8kefY17DeKX6yym9KF786peKvVkbdoNcAbWd+s+chdr3trKcFAdMVKyipWk
xjnBnMfCXGmNQSoao9jwjbaTz4YLS5qVI6kPMPXS6QJTTl7Nomu6D10XudwGceKJcKgkH8BkUgtW
ZCqx7pnEI9AXW2+4m/LFee/oThShEnMY47J03oRjcHTfkIrpD207gQeSc/ZMfVRcKF28vE1j3aAf
0GIR0Goja5+5y0jbsO9nZ22lAJBusiZXfDEnyXlkgpFgVRvSeR0BmPDWenqA5C5NA96WPkE1lEIB
0KuDKMl8BXHr69AX+mvTa/UQdrkgA6G2k8uiU5gPKrNtsDV6BFUbO5cj9yG8CQZrinwi9RIRV7ph
SsCHgoKWjj59073cdEA/tTlObVnX9ZNHIjQNeRZoYMzos208X7Wp5u2sOlL0yzwuqJdGTLVlewi6
M94qu+YGMWcXpmWtNPU93aoL9g+SQHDI+pyHBnu5rmFAqdNoOwHiRiQ317Xr0+FiOLT2VcZDJi11
WCvmUsegKu0uvhxdY4IUahnF2AKCSb18I+kFMEPYcR7IDCx2pUPdpSusE0raHR+8yNRsPwCkgUNS
QWhKhiCFd+Vdu/DKwV6PfeU8Tm0Z3zr5JMaAQr7IY+CQwo53ZFKV5d5VRGtf9HR/LbumapfixKkK
JpLydCDCCFLyAsVeKexawd8B1HsDCHXOr5Bgg2rL4KGFsaEq6okk3tZPrNLK+3czIdDEPyKUvIA1
aanFaqjLAX0bxJp5Mw5uyiwK7VpehGg3VeMwkY0E854zNv0UL0sTTVtaftoGCYERzd4JjeBldyq0
meCPJcUcbgpinGE/SRilVwbgMVX1U9q+xYrfbWTruUajeAfBkrGH0ZKutx1ZJigjEfZEwUi3WHZT
N7Eo79wRTzAKBkfN4wcHi7Lq907qqo9ZBWRa5VmByMcGanFs4Cctd9eZLZy/qkyQKKDaoQk8h/YO
wY+9VIPxluMwIFAr4RuyIVhIhtkyN6Jkrb4FcwJvZ1gAl544aScknPweftLcpo6807R8WS7NhFo0
Js5iahgNGZkOTaF1Vk4iP9wogtIGp3qs1q2hlOClxz5R7h0MPMUF1CyqOqBFB2sJ7caK1BMSxgcA
5wBV77lv6MREEDlydIHqYw59Aio1Fvf1CD53FQ+0wd6i50R6QX+/NMO2iKAPgsZvzBY7n1RYEfBZ
PHYDoGgihUTL10a0CKI92zocyrr+ADJsppgX5utLdw0CG0Iqz4lazdeIMLrzRq0kzw+jxuCmJHjV
Zd9H5Nk/yUGQAjRg+OovdlUJ96y2y15eN25hGZteoKEjcuxaec9Ur3MIAUak6Q+z1ks8gkCSI3EB
nYvmEb9VcLkGVZEIjn1eWvfvau7mhGs9Tadk7a0EDhEzJEFVG8WulqlcdlA1LZ19S+vKGWh7WxXr
NEny7NTrkpTE15g58lJTJySxvW0OT5ij6/nCELRw+IYQ6vDOSLFVrVxLyocp01mmXWc029B0RQnI
uli8a9qVtGplgO+tA9IVZrJqVTiim6FNNCicZu9wqvBMS6jrZRITGkFgaG6yIpfYNoR1IIadT8BG
WnQ+dQohnpwX4y6aZDoGFZH9vB5A+EI/1kvHCHsdpO6ePlWGfdXSgCcK8x18Y9dmUr/t+RKrNeKW
EmUp5gP1VfMK0946IIYN9Ct97+DcaKe6uJo7VxM+YN++PMszN0rPONoSTkwc/qpVrCfGcG2z7c8X
U1561i1fSKk/jGZdUWfPwWQBtUtaoW08pkXTXTzkkFJTYzSUdT+K5jOypu5Rc5al9iNFDM7ORmpa
+mqsQymV8Rhfe16C5CUGtCqCVjXGYh8rbV4HyJnAKgx0X5zQHGj0AdBCjlKUtRTtsqtoIfI1feLc
2rgpjHG1giEdDjYREqTkbPDWvWCepOhrHtkJTGHTBvU0y9dpzivvMmfwJHpNWa8TBBKF4e47Obv5
w5ST0QD4qs7VaWJ0unUuecfLuWLq43hW1p3F0dMrBLRSAlqzABfO4NC2USdu/G5sTPsyKS0H+uCU
TYZDYLfE5T1sQKV5XrJ2+kin0YLWWUW8zrUT93MUMPGhlasS2+WJ44qFFYsAyJ3vBkBK7ecMejiP
t2nvddqlrRblPenu2llNgxpdmk3FQT0dqmg1NBmjw1yp7BMJaOchCs5cY51UUyN8JDgDO+Gcu3t0
rG6/h+vJ2b0wPPMEAnvmoTK3hlPbEhbPQFe51aq1EnQYdAvrn/2oMVlAdoEtoeNCvlkydjmFdc50
mTkMc/DYFODdajuPLMpZAA3X/D4GPXQlth4539bLZhmm4k4z9GRZlbNrloHbtl3km1Zvns5ZXBur
WtZ6t+kOI/c+p49i2HQKTw19y2jMVkLmzucisg0strrZDHYjT+vhAPZqPKwv7Mrl6C/aGHUr2NYt
Ot48y/dOlYoUhJ2Xj6tUb9qV1kr11ejSCm1OdnjAhdoKArbM8dI1TXJzmEINuKX/ghQCs+LRdQ95
uQIiOOoiyNpZvtmjZr9PTlwVgSKn5brpy5kEm6q1Z46AVBYg+bAeepHBq3Ys5k/aqdSWoE/19AUm
c92t21RO7oYDZdWcC0Vt7Ng/FDNjPyrS+d1BGc0qbqQRCGUFS+WLtZTWqe5F4xJ4E5ivlaVm8ob0
SKut8FWLmwJANg4jfUmnYKQGcr8oRsHc18h8WTgyw/EkXM9BBTAiGQmA/XcwGo1G/URDPJurSaNz
IJhHtV+2maJRk1RE1nzwxRWOj2UDGzW0g/gZUrRCVsAU6FHAP2WPWlrizAFHyK4Ze031XHdabqwb
qcyRr9tSeRqrJVNQhNa5htXCooy7mo2Y8CPjhDgEXVdpmi8nqXGJp86kjlzVzatjZHUJ5zJKVt4w
lR+dntJLIevhURshaQa0NMF4nQ2FqDzhvHAHSmLMfbcjExp24N+wu012equmAt9D39OxEeiz/Ewq
sjuItPOlwS8bm+/COEBgC+6dCyOaGKKxCYtJXbp9nkN6q4b9bFrau2Jlw+SPnjPcaiOzDVM+GwQW
pN6dbTGoCBOsoWy0E70YE8CnY1y/V32OpljUIn2sehJIHHaI+EMlU5eKTdica+CFnnyK3Fxrc44J
BBpmyugb9j1/KHRnvxjCaPwpisExxoZG4oyFpef0W3r106RrooZxT1UyoLYfczgzekj4eVnaCyBd
hVVWm1xVUAiIXZ0FdrTIZIp5FAFT8amNHHWO3qehZSGXkemVLOeZwjnIco1LoqBGIeMZkdQnKuw+
2nTilc26jAHQuGzYzGUIGmf7XovzHbovxYXHn2b2SjRR+qmUgw4O282sxyn30i6MyqHlYc+HUQmR
LZMdblspknOsWQgbI5a08Sx1i4LVp3SLMchFoxNw5U1zSpCIFC4BAYnsTu2WB9NoaQZ0ZjHIAIQ9
DwnKv3YIY7gCB2jp5HzEQzTC9mVN1bdww3NjbwoBXSGN6+5lplONRKNssE70Zg9qveqNDpIyLS4Q
wNURtHpCmoV0jGUWN41azOW5oiRuvtITL33mZizmwGWv1UKbE9HGSJps2MnWhs3vkuVHAci2TiNc
rMV66OAdjjejVzfLKorcSKyHzoSVTWtPZYVxPzWdnxktvnly6ohD3MojXzFMok4IXeEqeqLUVfQA
vTBRJ4I8DQcaWqqVokAODR2vt4Fs5mYitkpUmd4Op4z1MaSgKFcYXyaGBNw4vh6p0KBHKsHEDm0T
8usZqwGn2EEq8UShYS6wZj1UpVaKVYPKcT5osUUU6q0po9DNF1tdSWtOP0vZuqgap8VIdgWMB5j3
HFPkdCOivMPZfuh3DMcOLSQdXxxNbAZ9P9wyKjjkEyfum1Kduo2xoETxnZ6QMewNXV73g2Pc8XgA
fxV0v0H6rTXLL5ViOIesQhJDKXNJm4mCrcHKmjjUxpTHh5TXXabXus694KpPESPz6cqrZ/JBiUFn
fIDXrig2qTbxt6esOhRVl4w0uFY71gR8MVWV0C0i8rqkSpQbkZVpzOZeq29alNo44EjLJLtl7Itp
k1L6cH1dVs3FVJECwIdDNoSjwjAD3tKlt8/A3y77ciQSDzj5qtW26a0yxv9Ts1bFbufeuY2nsP01
h8PpwtBIH19T1UjKS8Ex4zx1CPtDBx41Yo+5fmsUx4yDsm+LT69tl1uLaubiHwx3Gom1tDhNc0l/
hTaZB9qThdlJDrB1kFhXWydyrZQNjYtMQmnuLqZhWODpVjNBkTol+V4glfRWFC2Jd6k1n7ByLo+t
BU4BxV9DAwfB3Sg35FOVbT8ZmLtqyPRkrZRRJN9HNP4Uk/Gi+ahusD9+9GcvzT8f/upb3cwCG2L/
r//8079dyA9Bf/rHX/jB7i/roXp/6dO6Ov47P/2K7l+//XH8UR9oiD/9y4pFuJ+vhg8xX1MJKL6/
3B8/+T/7h3+AFG/n5uNf/ukNolF/+G0xb+snxiIVs39fmux/4Lh+fzn+C38wGW0ThiINAUyJHdqt
7AOUa/zo+n/5J4U/cimzI9ulVYXE/OGP/mAyGvpfGZBiWtQ6DAvptOT/G5ORP6Jxi+5LtkC4SCZj
798uNJ/88ntVj4vGhf/bv//oFraPio4WbU2HrimmN5gbtSmK/1z8awEy2gDuxXrSckQz+aahrjnS
Dm+yvumwBKxr5glDmc/nsZtvMb9ueFMkcWXgJdpZ5uQbpHN+O9/LJQ+0rg2qyQuS3OMJ6LYR038Y
D04aVOGe8W72z3RRgYcetgxlPTS5uBuGCrcPdOMk22oMxlYjFaV6PTVL2AOvViLFj7N+g03+IYaL
MdkiXGqygTybEZuagkSQuP0032WGtxU2nj3XxqpC+Q4vFJusXmW3UFkQpsjrJQG6nMJ4hvdtWxsj
RzwDwZ/d2NdGEf5wE/xxpX+6sj9XVX+5sEd1cGrK0i6jTqz7tj452FNG+9IcspVsrT/XHfTLKx3V
whsMvsnU8BV6+qWiP0ntCzbBt76zHwrEvMABfGBrTOwRy8MpOLpHHAoP0CvE2o3PUOthfrlZciD8
ETuFn6u3sV4HXgPLvs3Pm2Rv1OU61+0wyy4YrAvEoVDX4EYqkpNOsUJbPgyUlVXtfuLGSWq4tD0E
fv5+1tfB4Xf17XzKLoXQDyeLcaXMePGoEWWscSywq7mpVx25xwGpoDBY95Scge3cNypcUdYJI5tf
tCx9I7j9cgEOnXmH55gy+VF3D510dMSMUqzJ1fGOsWi+ZbEaeMMDJgUU91REUUI6bE5FhE/P9As9
Wke8vT97S/E9/PA2jgr1JVQ4GyWCWGcUI3Cw++STiEEIMy39i3vqqPPh+1f+w0sdtQjWjSm9JJ5Y
FsidMH/rRxhdpPrVJ/rWhv/rlbWZ0fwGgTvuefAS0TAuzpXt9NuksXaZGgHdJ9tcNhsleRDeKbI4
gr4TkjrXi3JeH8wVy4NOoWQh7181Ktg2orTXQ3Xl91f7aBjqj0vwt7d21PxhMhkqu2wQawbROeo4
ZJU7+ggO+fl4Re5rI23mhWR8/fuXPeqH+uVljxZkT5nmqJF8ya2NZRxjba3j5Wvkuoi+mhI6PLe/
u/hHS1RlpeRsBl5qnoiARYUG4/n3H+arVzhaOZJBqEx88Arj/Cyc2274Ymn6+xeLjlmL74lu46MH
k4ErojKHRXbQLvr5bXC4O2LL96K333+Ov/s4AKiAFQZWyjzumE2d3pvKjtdpCw6qcsOBXV1ufv8a
3wdnf/k+XNeCBsAUnqEdPd+dFcOqKLnjULezwtFLD9I/Sd2dvqjYckgwu5FPDhE90bhO7X1nqQR9
HDYd437i+Ej896lb6LzHAcMAcjsaZ+4k1VPfTkVH/pIfdUlP5pHcKoV1Wk53Wc5QKNZW0sf0ESQX
CtKqcshX8Gc2avMe9+NaJUE4oD3onTe1fcdZEuROc6I06onGcZB0jkui2eIgZoJsXyjqv3fmHeD/
BaWYxUkJRXS7eDtZ8f4dnm4sMYrCXDvKsniJ1mOZsYQ3u2jCwAAHEj8gRRicQ9oJCpAt1fptj06n
4RDRFed69aGepFr9mgrn0zLlvW0tN5x6r3tn0+vnYzpdDYXzSTqRvDHlO02soky9oa2GjFGy77lw
XcJJvRYwuxI/HTyq+yqHQCe0x0tRxL4yPovcotxlbKzR2nAIRCGVB3l8rhN4c4tcln1+nnf6ad6+
D4QQeNau+vYth17J3nj4CGNlrSNtIa1Jv85LZb/Fy/NgPmBDZHN6saCCRgi77HkIzckL83Gh5ibQ
1GWr3vNWM1iGscvOlsndD9OB8nI3tu2aFOuJ7VFgRhWCd0VdsrNsHtc6+sTD7aKk721Ku7OabRwz
uebrCV32zIGdopw5tdbWKebDd3eY1ibSD1pySL6rCA8xT59CGjyrQWf6tNWcG3K8aWgBG3DNTO1N
lBS+N+9LHblNm64GfQx01d6XNAuYyBldbNGl5Y+H7YEzckaDjlMzdaVbPkUAKvoK98arUmbhjGcS
HXfavk/8EEIv1Ktz6L72nrJCorJK6cBqe3PnxHt4EqROkl2WvRhGRnCmrrnmFedW2Z+Z6veIoLCD
TBm2zKcGglOjnjJX1hirkjxULz3avC46awyJQ7wZdythXz+8HtKSpHo9/bxmnkm9VME4LK0SZF1y
TfljDectnJoypKD/SLaJ3e9gaeMpy9G40QwDRG6tM6sWka5GgHHmJZLKjL626uJcOCZKxuw5NZeL
yq7P62W87kb3tCSUVU3OpvEJE65kdpNNP7wNpudjz7g38IdFzp1siV2SJojr137+GM0kUGlxMxEI
gPIkEJoRxnY3+lKtEnUJCqrHyeWQYsvJ3jWg/kbPfqhpkJ+wD/cBgdPGHG2uQ7PRyC5RdzmfmPzW
8hrDYcA8VZhRkywwjDb4RBAn7cuWMojenE1x9dzw2wZdX7n1Rc20EM19GWY1JAcXdY7cYhhXaAZ8
eE/rVEkABd0XFmeHttziMOCGtNZ580x/4CUI0lViY2QdmWSJmwCFFIr4G/xKKySegaI6G4l8abb0
VacI/xBMMhOFe/xKlNZuxFKSzsYuR/yVimpd2EpgqdG9gZQYe0EI1Xm9QJCoEvLT6cpsp1OPDm/m
hwnRVN9qyoY+Dm7Lstt5qFOUGSPVgZ1ULMHhE+Zuf2N300bqz3KMV1l1Y9EnyJfTjOddXV1SyN0l
VfnsCuUqxaY0dRHzP6S0Ylh+yqli60GbJX63PGd6HtI3goEB6ceMH9RCaxXd9E291nghrWnWZok+
KirWojO3RjTsptTjEZZrc/DoIYv9vMbjql4SaIZGS8ecvfgpVu+5xNGjhLQAndJWsIKSsIlyZ5+I
+MFjgVLwpJX6pzrRc6leJh7JT5mQgW79OaaFMb5ydHlutM+WHl+LYdpJedagJ6FHc0U52EfZsBYH
HUq1qw782yLfGCx3I5IcesPuRVQF+OT2wpYXmlOeLXm+HSxaP610pSvFLu2AKsovGum/jfD/tAly
qD0gSWgkRmPwy4ytQrIvScljra20PsmoxNHg7lskrWvcyqperMuKIyEKtGk2fZoDQziiK9NN9rlU
zyAvkouSCM3vc5yNv9+gfwkIj97Z0fbsAAcsCMgENSI6t0R0oUYzkkHkK909Zfq115Xrvv+TY5/k
BX6+HkeRuEFBTcy0la4V9MCeed8P2cakFeqLz3aI9X657Br94QyMk3s/ZqYkTncAWOR8OIdGwMHe
WgrR9tBfDqpY1YoTkkZaaeN4cQgA8NuuZrSEdOTtyS0+xnwVhUESsg3knAfOsNep0Ftk6A5n9GS0
GBtF8j2Yd2ZrcGikpGnNocFvbdV3DHE8NfZutO/76z697Wl2mWi7zTvNh3MntwZHQkkXcSQCCzKH
WucrzXxsopVhEp3EHZU0bJ0ubYeJtaFl5lwY/aXpLGvX+Ejz+DJRusvDM2dr8p5a5iM9byGTmJcF
NTeIv2eRrNZePN4ntrZyvfGqa/TnsZwDJ7mxY1p5qP6uy3m56RSV5ohhW83R/TzajwV5wIWjiaqL
jUI6k+Kc3zjZJ31jtASDPYL0idM47EoCDTYSI+OBTr5ivnwbGfjNN3c86cwSGIlZLQ635bnKmpiI
G1NZH9I47uKeSq7xcj+cDF1N/eom8r6IjH/JHzH7+T0ZxXwSY3iHyPmHAaiudSeLcq9Y0+3UpcO6
2SXnKcngnt6Ib7fon8o23tYl/z1OGf6UZjxL3wAl1p/9b39q81Gfv1CGOv6h/wuzj4fJ638/+xjU
b3X3l/+2//go0ir+73/ZdcVL9d79mI08/ILv2UjP/ivMRANwD8cYSrcuZ9rvyUj+hDwk4xqWDVD6
W5byj1QkXeV/dXWEAZ4LTQZ4EX+n48FPyGBq5CJVGIEqTW/WYYLgT+lh7J8XWJcMADQh2C4AXpjl
5K76+V5azCwr0GrrG1vSu8eINFV0sXd17Ei7XoR2iTrxpqhUqhIEn+p26re2sbfpkJorw2+TE5r6
WsJaLLwJcKJALlt1DAz7RLhstCvbZAPlKB223Y3MNoayUaItoXPl4L1lHyXQhOFvr53sRFQ7YzyN
WJSSFV1zVhHacHqmfbPs0hq72DZljkAMfneW7J377rZ8n16sz+ml2ijm+VxepdnTbO7K6Ivj7lEm
7tcrdLiCPzxtOtY66qOoPUGVdM/zh/NQP7fPuh1YD9jdEt951ZrQea2f6+fhgwQuNdHllfZ8dHG4
3tbD/DGnIYYolwIU8wj1dqRnLXuj8ZsweJMtZ50RzIeOrR0MPy3GkfhUKJ9zriFMTeiQuCSS++Fu
/Ttp0m9GjL8tX798JPdo6sUpms6gd5JzjvPYiCu32KpAkZW7Rr/kQHK+fCpX7uNwWt4u9/mTsVKI
0Z4Iqloki4vvcRAqA4+Wgmvcy5SwqQ1y0jX4i//Jt3mUDfo/9Da/ukHco+zRP8AN8tWq4B4ilx/u
+f/3VoWfk2DfniAAuDBiVc8GDmIcxaWlVrQliE9jk1YtUvICiXVmgFqhvSqfe/dPJaF/fbWjRfo/
+WpH1MrvL2cdYHOWbRwm749WPHFoyjVlam6GwN7QP7oCnxFmIQ99wBBFIIOF/1hBGsbrOIxD64vl
iaFMbq+j9Qlk27+9AedofSoLWk+iMjE35mZcqStiO7pgTE7eBHmFbz3OQX+qwnI1A3nrvkzvCNgP
w2r0A/j8U2E0it7Tk+bGO3QEYI3YCHoUX9OTcgoMSGn8v3flR3zVa0Fpc/wP8jvlnDbWfp/eqaPP
/+Kf+YckEfbHv5i0mDi+UXJOoxGUhjvfWXGuF5SQu1XW+z1lmdv4tP+EA6jcKWfZ9cjQWe0bJ/Fl
/LS8NLQjMPp/DrL7mhkQuvpPI384Ffd2ETSFf+pwEn/U7rt3uckv5odxH4fldcsol59e5y096r5q
+bcMLeCuwv9bBAzuMSE1JuvlKdtpSagQ7n4m/Oln81a9NW/INEYmS2K6UX37/F09N9h2JS5P3nBg
NHeHRE4ccPikcCOscKKbBmrjMypdJkfRK/tz4g83/SZqwrQIkr1Kl1vw++X966/5aH3//1/zP+LX
/NVqcqxN+a9eTX4+LP2xmAFxIMPPCD+L9s9bWSsnzU0Yltg0evzB8NnlPLUIQJxu2XrC0APFoMfz
93f2Vy95tDn8V7zkN5jHL0sm5WKgmpDhwGP8/DFzS2eK3qjMDVmCYAq74PZhWSXnwVcD01++0NHm
8B9+oW8F3uNPBD+CQwlH3IPo4OdPlOp1wpxta25kRGuE4eLZrWhTYDg02+rpNK07Gu23jtfZARNT
y1pZmAsTNnUEIWZoUnhzQwbmyt1M69lJAsYrABBGEXdJmCWbWXnFedvIJrBdluQsyqswym8n3SzW
KrbnL+4JrJ2/7mk/fpyjL6jqmJ0XzJFtPCMoAwZgodYvnJoWvxW8haCQ0B7DIg3ZzJj+VXz1caKB
rL1k44gkYxi+M51VLwWTgWGdB19tun/3Mf3x/R19r3FZqF5W8v5mIvudwhz4jv6vgnTkjbhwH+2t
u9UfG84G7sX4Ks+mjThLv4BgfPWVf5ua/yHs/Af/yo9RBv+7v/LDHfebB+yYPFonZaXqCmFe+9LS
mMe43ks3+MlZ9cVG/9WtZR2dJv5X3Fpffdajovh/+LMeta18324cMDpY9Sgc057686rVyaTIljE3
N4+PanBxEfu9//R0h8f191vMty/n+Mv78XWOlhNGC2xJNzeP60l83e+SoPXVk2gTb/vda7MTOyhg
KzsgQN4xiexvlI0RRH7jE9v9D/a+a0dyI9v2VwbzToHeAPdc4EbQps/K8i9EWXpvkuTXnxXZmqNq
dk/x6ow0kjCN7OoyaRgMs/1ea1PucvL0tDItDnSuKv4owDItyZ1MVHCC7tAzToxFo35Gx/XtxMzl
Sz3oUQUWI6eYSHIF+eejle1o2OEBlNkJRSqM9+qJAtgzP5arao+6NOAuamjzvNG8zydvaSzCzL8I
fsexLG2YOUrX/3bDfFdvf9gwrLrxo0uPAneEIjNsmN5G6Ze6ah49KJnCQU60TK3hvHTo2ed9skEv
IfQPsvwcVw3P11jv1hxessE09ul1FVEFrSqhGUYm9F2JWkDkOV1QFxnSNSqP+4lWJkrgWfX2UuHN
0om5LMSHAf3hJ2ZxxWZh/n91xS474LMVm1nKjQqcwgSoHU6e0cLh4RZT35VlU3iXUFxKMvRd/8u7
ZCYuf/ddsjgJM7n6W0zC9wKIoKAC7CVi/ognzWmVUIAvTOemlB3TfATpdWmfne1jRlrz3o5N8hZY
BMUUpr5/oMfGkoh7Ou0kqpPRdNcjvQd59E1M3M9FJNDAvnd+fxmUPJORaYc60mLCoHhHI6jcQSBI
PaJL0A6vVacbSY+8HH5rVsW6WeEg36tblO0dkSR6wStLyrkjjn5rS+SWs18rV3pQzI4ark8rNyHI
q9/4cE6OvnW8TSma9qxxhXiJ63GUo7qpegik0cFF+7qD5laKL6slziEgsT2sQ/ttor01UdTHWG/1
WkbXzfUBoSnOgu38Vmx9Uz605I2jjpc4moVWcVMl1HpA/wo+PqH6q26+pdB2Fq3JCp03dvgMVf0c
OI0d4VNVIjgRfTkoW5JtDrqpWYrloXrAA5QIxqGaKbEaG128Hpq+8GdQj+J3g0aOv8nvIlxSNZUr
bcfCZYLDe3fxe7vq7Ds0V6xwPy8JfVHNzcPZvNvp5A7hLXp3uMqoI+NyOSm8s4kCFOLc4alNA9AG
EMPrBC+XViikmChvF15OVrvTEZTzQN2xFaJa68Zij3vUipH167BH9a/d0dpsrNZcd/T1VoToz0gH
5R7TV7Qgkgzvqs18A/wH+37dkW3qIS1sQkGYZ3q/XcdebVYWokP7cLPON+zDSrO2Q++86u/RdFmT
siBnOq7iTex1NX5E5ocA3pJy9nAQET6MN+NK2rPLshEC7x1ft6gaxiMhr7sHxfH3Only3ztye8sf
IxPtuTwh1SYlFea4tFCzfG89JF5roQHLKryHxkSvnjmtzra2xTRzdCBeQBzwNBI3py5whRYcN4mZ
ht+IxQ8HYRalKrsJSWp2OhUCNlrcKW5ga3uFE5H9djAnO9+cLfOgOahoXz00niWsMER7tC1qLlh9
S5JCninxf4ukWJqfmXVft1XVDvVlftim8rfa/mxtOdKQij4K5mSi6IqunsYNtSQHZyAnvB0cNqvV
6bgwPctCa2bm/xBaP4TWf6bQmtmOv+ehXJIPM7Py95SfImvv+kaYI60FaplLzdU8b8fJrT+F6LSA
bqrN2uQdph8bq7d7u7M6a7InfM9uBxslu86ZsufGFfDRTDT142eWkWLPjXSyUWXsCbZg6yt0a1DB
VGzRQjutlViRFZsciqi0q95F1TdF3aSJklh8j2BRK0dkfMQOaKR2fgsQCaqSTWdavaWseuspMA1T
t5gmVZ3YO1vcaYQWBQeofcZfS5qZyNPAZ4fFkMKqgTTdgfiY3DxJ9Am1lxcXH0aD84bmyUMB7XiV
OIcr2WxhGPXkqqAbsSPJxthVL5Iz0Q00bU42h83dg4qgQEjcFObDbUEMMl20NtT06/oWLaYE8QyN
wAIcqUKOHXll8/HOBnR6h/rG8+giuxgVr6+vyIauaGwldmCnTgbjVSbA5rBLi01LaDY3lTnaqp2Z
pcOMAp1qZup8bsFiPRfWembKR/oQ5gE6eJ0Sq9dh9joKMCs8alOCKmcrue5NluFkyyivzlbp5Z7u
lB7Y6C3JBv68JSKIUsIKjyzFTe3ACu0Yv+WIr2dWaCZYcMnUbPQgX/5WOaGNVjca25HV0BTP49U2
YDqsyc2cBM8ObrKFz1saJr/PgBVlAekEJmhiVxuA/9WAFCDyXnBqCzXz3mSNJix93xIJEKgtQBzC
mi5hg+Fm8BAwqsjycRsqvkYL1pupweKurI5m68qS9qoj2DwCQanX26UJEA1Y4Aq2vY6VAac8Fd2S
0hz1NFbokuqa96addCw2lSduWoeGFkiYKALAZMJwhFXuRoTAPLcqJ7czyz577a7d8TZ6DFb4pO3R
RPkbDVcZ3gVIUWxhZnq2Jk9TGJIwDGl02+P31CrMAZ+IbkbY0kBfwz5uLXCR2mvEnWCAik5h6ZaK
Lw03BKOdHR4EBlxtY2wi2zVoT9Trcd/ZBGgqHg1J7IRL22dRVMwCVj9ExV9WVAg8EwVzG/+DWpg7
u36HtopIh6jo7QaCorFUBxDK1mD7x+FnxeDjLImQEewZtLY6TD4IJm+NOIG+w9MRVRK5GduZw9GX
Hg4rNq3lRRIFXhTcgc4EpIsZYT9rOIQpTZ2VmW/b7dlT7wfsZ5n4iMNOq3GPsgMTpyKwcluC9Qz/
Aqd3pEj+4yPlPU924n141dJ0ZXit0zo4fLbkoPoKVaCFh6Q+1S8nB9JuqQzlQoP52TzNfKG6j/U8
PNeyA4CNy4nuKDz57Zky9dhZystk92YJtTjZyn3qTZBKMiSkZDI5yR4qFYhKOyc1M8weYPqs1Gyc
2A4xbwF+DiApA8s3AXWF74FVOMEqslK7cSpHeGayF11aNId8jc3CCU/sfRmqU9hro2ME5YuSOrPa
4n2QvcIz+wTBje0K7w9NrI2VUd/kMOH9OnPYq768EuAdeEWBR2iz/4MV4K9Wgls5+I4rRlZFGyfD
uCOsS2pXNMX/6NnCV2aVNsaEe8yhBUAkixEwqe+bIe4jc/C1zRx2PyxyEaxic3IBU4grse8YJ+6k
wKvYlS9fe6Yn2PsgbHe9m0HkMrGrwYAA0TiN6CHxMtgMG2A9w35Ar9BRWTVeehVfyfeFB/EN3dru
mmthhWZyW3cQsLkYOQM8e2bMKHgIZufkWAXwrdAEWg7Ywogt6VS1Uqe4yOjCbHeTBelOmXYRsV6g
6cR+HLAGPE6Jb6G9hIJu3PRJfKVQAQmFxAwt7hDZiR1aoWXGxxDGCWdyUO9MdVVQCLXtW6ObOgFU
2miPZobnWhuRhC8GFs6XzVR16LA4hY79pZmxlV+NpkA3ul2+KzAsfBpuQVlngsv0gNzuKjBPBap+
nBRRntzRr2InMqHmfeg1n8IoAQwWtWrMnIKZRErGQBSooNxWcxRqOJXXbJqN5py2FVQlQCLJ9gwd
KmLgNU3Me3B14KYBUY9JLLHt2fnyrQjFT8B/owEKodbu2vDO5JbdoY6JwZAxfNPtXORzoXI7HBCM
1qytziwQ2iot7Yh2PFzbsAhUX0+IhqjBRG9cH3oedpmLULjXeNKq2QiOeC+/qC+NOb4E2JmNmWxQ
ZO568KvR8sccbSJSmF8ZWSOUY24n+97uLW6LpYXlGTioUjtwq8FJLfqeQz68v6f0+Ip0Oj3d7J5i
cnNzJq+w+nwsGO3c+EbdmWtm7QlkIlcsxNKQa3YV8D4SdDNRA+ahhnBPBuPwFhAAJsIgJttmIJh1
jUOAFdYxUxXs6RFbiy2pYup4Obq5zdw5u8W6wMIwWchmy8fSVNgHI4lM5IVg9WxQeIXw3tmWVqG7
wkoycxwd6Nh1bDMhW44t5FOAUeLnGG9IIVwnC2BzhGpO4WmOgImTVuo9h9BQ7uC26E40FTpiYjY0
dFl4j1iGY6F5bR/s3wsrgRHhY+/neKCuDbfABLWEvxpYQrQqWiE+hlsIWSiX8pfPROospCMDma3s
AeqEM8As08oCVOJFmH6xUNmhQAbl4p8M98z3YAe62EH52IErWooNIKNrxRZMsBltgLVDu12w1vB7
6/EWKA4CV6bs7Kp0y8xUZVPazwLpbiDFzHx/sVQh1Zgcg8Vq53ay6pwK8g7W6xHwag5ws8xu2zgC
gbTD6yAJHWENaDyXSeYYEhgAApDYqEGzEsQ20TBzecDNMEoq74ejeBJP0aZ7EHbKNtkEHuDi7goH
8Fl4l2GxECkiqwe0R0GGQ3YzSU8wNiZloRkSJ8G5VSELv3w2uhlpsJEJWr4sGTYsto0b2DoOGVsl
FmCEbb0WLHS23p5tvArhXEAg0fOhp6o3rCGZnfQUWGyUrYuArYnAXWvBgs1vAjOFjY249N35rnY6
s4LdGUG+Jfh87AIrdnSIlxiHeITSnrCbnmpKYVbX2J5YJ6xg6DTPgOHB38Qj/Dicf+YCxY7gIRqK
XYhwKbNu8b232UrXCLUy1clEM4uus58QZoTKr1DIUyMYC+8UGxE2gxPtR8Q4QfBg506Kc6NDPOJh
AbEcsomFVSG7MBkhdrWA+HgHs5qHhDWcM9yt8n2HWkhb27AgLVreIMYC2O54yhRJgf/hbtjMEu8Q
Yh0wa+ztwF+Hr2DA55AIO8LsuBoQ2Abc1AAzkmLOUyodsjuIOc+nGdwZrBV2QgbRxhxeOJ6oGGUJ
jBafz9ydzuMJhQTHcdIuqugyMy6Hj9QezmvOQ3MhpAEedrrqHUDFefmOR7FkftuvlC2WiwXdSfgE
Vl/cpX9SkRzAVtoBgMnD12Ur6ihX/aJQB1LeJRgCcyKUHbrI8MWUa3Lje9wVFPM6u+ndYc0UM9tw
7BM4uCb+xaiAUWLnZuQyZxCgovQZnnfjAXx2jAj0EB5sNWIIbdHeiLZmvbCNHMEoODvATMNYgJCP
qD5QkPal40Z2Tmn61iFQrWN1OyRCKqyfYUbYyoBcAdABoa/Yx5ggNtvyVeiwXc085OqOzTa0Ipwd
7PVrpoa4a/Za9ledNi77GXgOjnjFNCfzBkMHbhS8QbyaYtstGISLPrY8C/7+8LF/+NhddgCuQNv8
19+FhWjcnG9cU7V2SoEHCoMZYJgQyA2MvCcmJsXtUlEmcJwWnDz2/IcCgB/Oyw/n5Yfz8sN5+eG8
/DMgOxYB/cx1mWV2BA4UbgYT3yg1QEzaczTYxAtNgEvXmBUI/a+useyEzVIFP5ywH07YDycMdtcP
J+yPd8IWrehZoupfsqK1BXk8b9Hg+QoUBwMyJcAeu+Q9So8lzvONtGfhK1Y5hvwjQbAC2V1g+CGH
WMI31RA3nkzZEpHHAFaRNSEOw+LbX6JGqNPTzZc3FpdN6FsBzJnXu2mF8Db6JS3FAeII8ieonUPR
Y2EGKH9jARkW8/gSZ10z/3ip7mvxTme5jr/unS6mvy6Z9A+e0X9o+kswvrv5VYnhBvO8AjaZrz3I
c92LQGVv2eZHtA7xOhZzu719vR3pM4KqBaogbvGH0kQ0fY0ywTP+l1honcX7EIfyJvP5aiL7Ci9t
KILq1xzZo5Rgle/zfePoh/ZOPEg7aTsc5evSKhHQrlA5oiFd1SC0RA6HwwtA5ckBUc2UHBCKmlbT
ivdQk7qanMoEvi4q7ApER0NboIUH1gsE1lnXB1isEA4jeDcYt1YPKdGO7++nkJyQBsBYOfM1Mo/v
yAFIuIcEqfoMdR63rGyTs9e3awS+Nx3x6etrTFH7gVw+ov+3tXmL1Abiggq7YZRwoiqkY9/ZM+zu
j7eYi8sc4ZNbG//hFayo4Pj6ebHH96PoH1Zm5tunUWKA4aaTUavMHmukfOjj2QLdKLnXiH2NRpy7
ngTkaiDXl152B8XLxNoQ1L9sUEFzgx4ZC9QSZoSUB0vb9Uiu2DmSV7EFbkN2LzFirrevKLUZL7P2
jtqX2HofF8pNGbTLt0b1hzuZGdWDNHLKICIfoD6W9/4byqyd80o7RU/qkT+Kx+HQWECnG0JTRIml
SkFcPAiUAwnmVj+hOVAWARnCummG5+JFRZLP5FCLDTRTwP0mFI2D4lG1etBEPHy+AhKL9H3jDHwY
98xQB2UfyAJ8nI1xJ0TI076xFGhGXwTkjExQd2yjgN5kNmK6Fmcmp+QUbgE+j8xdhIwQi2mz+uDP
x3RpsPtsTDOzvq0DWUpKlltBhkqmyEQhFSLZ7UZHHRfL56EghjTupdYESHmkFawClUDC3dleoXYJ
HVPIbCIL2FySMhL2fIyhoiYGOaIzUpjpFjkjWE25ozygRXVhKwALaGFO2fMf5HKcA9ky4jB+li3Q
MV6WpEXeYMtKfkakbFl2gOWHACaHWrHgipUv9cjE+bfI/aAerd2zarTmJsV3lt5mSWYf6WeWTmfl
TCz9zYrs2X6PaIbsu1OXViCb0jG4ro11BRIsMKQg8Dy6McqvG2QwGzPaDIjSPan7yXJZyY9OS6h7
JH6xijoSpw3yfr19SachCM1GnHrDpSwJyJuoX5P3rF6ht6QVDxMB8IqoI3PO69dX33p/v9m8Zc7V
AbjSeU5w/iCjIhP/hTiDp3fDbFChxqLjLObN9D77/4zIN/LWSBR0LvudZYFYrBzpRQTXgYSLiCJS
tv/i9hJnLRKdnEf+KGHLg6vpUoOAfl2XTe/5RnKBB4jsWUTAIQdRAsG7WkFinEo6kpLe8OQmM29u
TgWSHJc7hEw8vr7m6L1jMvLzc/B9C/GXs3lp0Pywj/ghBxdMh4FWV+leVmF1odLM6Z2CVYE5gHgz
p414t3DRJW156cL7cNUf2vLfpS0X98Msa/Ob7IclYSzOjKc/7rQsid1LZeCHjftD7P65xO7MQvqT
afUlQ+kCFPFhd/07DKUlo3OOtf5nMTqXzH5xZiD9ec1+7btmv6aBYpQHeZh66UL7sCuUogoAOgJT
Tz8+9qjc2ReD6+3zU7MVXBR5m2+opLBS8pZsA1hyqD0wuxuU0dNoBfPCzVao7SEo9oF79zJQQLKi
lgyYVY5qT9sCkZiYoFCv3yaXuoqcsi6D8MaA5R0lNDyWTpGT+FhX5Ai6vg2aNRdM2cXbm/lnf7Hb
uyCufuNo6LwmgD8IrbxzCEA9a7KoZQYWD5Lf6w4lMvKdZt4z05zVwg4mjHFaX8P9gAOSuMlavdSK
VrTbsjrQ2GZtIj3Qa4DKSzoNhVao22PNA2a8R5GVnW0BWY34F4pnkCFnBZco5aES1jSggxOgg6AQ
AGDtKAK4063PDbnFm5tZC3+pm5O+W/n9YeVmVskI1uNcBNOggzCBQtbHW8Q1bu/hR6OlgkcUxHEO
MiIuPb1EJw/O4ViiXUag8EcW3Ammtj7bQ7MjUvlAMkoVjGRve6vT52u4eJsznfk73qbCZvSz+5wF
ChSpiNSuRqimslgtabKbEKSxI0ivZxZ8efZ2Inl62DigMYZ083YI2QCdBs/sn1HsiJcVFDE0FlYY
rUfJaTzZzg7iRnXVte5mp6Alhfv57LERfTbiWRhh8g2t0AeMGNi29hoBvc8/Xv6um/9hD860WJsU
ciFqkB61ATAokow0uX1mzWTCRqY8vueowFRcVqHJKtFTU3BtYc3KxpkHH9qhedWA1/q9Rlc+IhbA
radgRkX0QqLp1WSB3RK1zP3Z8q8+H/jCvBhz/3dQeS6cMC/Z8QGtY8clB/v7WuOXiTFmIfiyGsJW
qnCBdYsu4glVoUDLogViewihcuSa7YwJvvcz4qq2Rxx0soHXhCj2Mxg5yRv+vR2AdXNTk4cSNm1N
MEo0tLEIYQgvfFWTK+hCNDidEMd75wmPsrz3hdWV2Cx8snsMEc9/0OxcOYGvMcRNQKqMGPy9Qe4r
BIBZtPhxy/4CPgtWzgoF31qbB7Z4nFMT8/PFWjp3xkyM//nPncEkyYeZ+7Xnbmn7zgRu95tv35nQ
/Wtu35m4/r2274J2NGYy+FdpxyUBfIlkfdhofxoB/F3APF1HIkrjZQnIjzMJnCec0Cjgq3aeQ7Qn
NU4B4B4EG+8g6+gJJsoN5J2JXgqWpFroXBB4JjC+FWy/XHwmndOpFQtOGtBfm9FqF6OjaEIv7Ght
L8heezAQujmK7Vk5v4FmqgFgU6jzPClohHpe16egBnkhSCWhyFF4jZ4uJuGBqSG5vek/oCTd3u14
3Idovse4i97R1yCegyeToSunMCV64vHj6A0OazWKEbCPbN6NgR8SoIsESRoWaI0t0U3g/2R2bIEp
hOJJdH+IMKDB4muK5hOzoys88bmwBe7mwuTMpP5YRUCh9LEypoZOahBbXCT+uoDqGWFWsl95iP7t
IygN0U3DemvQbYy/aOT+H1ks1oU9oLdcspmOKAjrDXg08M4Kf2ZWE+vEYf2I7NMeK4LnvjzCA3sN
8IPhFF6jBQxF/KzMv0QyAylDS0RyUCfoNqQD2rtYlh2QW+x3lPujIwlt4Ro6BvpLg8UZ70LvVE4M
50v1vrASoKAG4NF8PmX/RD/9sp1m+ikLhKwrEmwnHl5SRZ4D4lX06jqAqQfTsCG5abM/sD2SWbn3
+Hg3mncSBXJdCaPn6ekVCDbQ4TF5Pb6vIuz6kobYDJm5tLaLG3+ml/6TNv53YaM+SqSZUq1AYNSX
GVbxYs6zSAV7sEVj5ltsX3vX6CFCLxEayC9Gf4T1vX5+rmCYHd9vbwE98PYGDnYUgsCW9ZiFh37a
zer9/R29hCeXvnNIx7LFXYmEnWd6QotehBadEn14uYMGN5avjVen0BrJgsxbvLuZRv9r3d2y0Jrp
+h9Ca1FozcySP0xoLVoKMx/zN7UUvmtog1pbAKGNIEqX4MQH88r31SgdB+hCaClQYuJIFxDwgLqb
yOpJtXmSrhZk9HchZ8Hb+z+XnN1uJHKtGou4ZKgJrwOvA5VCr0HA0j7LIdpPe6F3sliozSTJMjuf
gJEqC4AalRNi8PL9+Qyg/SrLG/DllYesF5/LEDRbYIR3FC1piHHu+aURf9dg+GXE8syUy+IkUfwG
ghNIJD36cFGSE9LSk8i4RXwQXMe9WwIG5OaJFSWsdgHw+Rc08CXK/41B92EIM4MuA5viqMoYAhxr
JqKvAos1yjE4u5QwWBjWNxigTugI6+r0nqIW4nMbQGRW0WcjmFlN2dA1SVhhBFvmHb8etwwQcW8D
06+FhbK5WcXkuHDJpXmfmx2//bxfkMw/u+uZPdGUXXvmONy1YFew5FAXVlHEvhDqqFBWUDkTzgsD
RgCST0/O5g59fMw0zMgxRzVBZKJAYnSxJMz6VRD2R5QDRUrvt5/P1Pdl3YftMVPtg95znJhjmLfQ
1s/MwoRVBrMTIQ1m0t6bTk+BR1SSAwNZfJEBLMRgG51dzfwQ1tjtutfMEmBDP7N4DEUj+u3t++n9
85EubmS25h8Ezm+/kReXdKZJ/6AlXRKTjLXs40T98WJy6bTO5HoWJNI5KbEHM7I9bNzP983Ch89r
m3/dh1+IJj455Zf6iA+bMh4kMKmeoZJwWhocYAEwJQAmock2vmvJhnXBRzTdFSip6gA5BnwNwH2V
ZAdwBlbx9MoyDg/W53e8dKbnlb9/3JkWFoyIOYj8b2FELGijy+R9WLHfQBstbpKZjM2mCFygNdsk
PAWUWIBCXlhL0AANZdC3TCdw5HEw4fM7CoroRgRAEtvfoRbRQS3jCb35dMEyWRzTXJr+GcY0k6+/
5WH6VWSZ/69r2vopjZ7yv5Gufnvq/la8/+3UPrVR00YvfwXqywv77z/nvjxE7csTqJ+/R3p5eesX
1kvQVMo/oZxBMgyDFyVZYt3YX2gvOUHif0KZg6xJvCjKoAqGvfMP4ktRAlsmmKIMUFKKugQWhV+Y
L0XlJ14zBNnAm0QBbD5//7//BzSkwVtx+CJnm9nvf8t/6T3/WtYrINbUQJWj8aqMbkBBUGYbSDVa
cL90+bRThgKgUF1H+DoISD5EiRlwKJj+XNDOcMXZ9UCBIAkSSM1UQQNFz9eatpazIRKMUNxxOeh5
+VBOLTEqELXt1d10Fh95IUU1pt+iwNg/ZCDMDVB4W1fi6Hw+kEt50S9qCAORJA1coyJ8I8HQdHVm
YhdTprbnpih2pRSSahIn4udRRYRsCNdV89RkObDNIvAzFHKouXWtvAfN+ZRrumTKQ6fscq05doWR
O5l0vtYKoFMPmSxcibLvtjFf2EGRoWuhlpDQannJbIM+8qYHUQUZcR6di4WIjDSrZcT9yIBM10Du
hCC4JoO++uuJLZUqzJShErdZSIOQdjUBOLn0oqgxiRpbFlcd78rpSk68oLXr1k2bI1jr64NRenFH
NBmky1R9K1YZmlhrpwEHim5NolWDejOhuN8KfJ7NttiOxSaObB34SS1pOFAREZRJK1bgqZUpaTSQ
rzIDXPWgZSMqCOtflYQknK2C634H0rgyd8M74TEd6ag5UbMSxq0s0nPlFSit3hv5rcplRCpecmGl
qm6neRrwHkFI5BYACgWtc2oavWnwjpA5ne5ItZ2FZtfRCTXOiO8qIGpngCQZEJ9gRURmedUdapTU
6yQ9ljfag/RghOAnJ9rBAPEQdAlKSpq7RCcGsshgxEOR+6ZHTTnw0gwE3ID8dFccuTtDJzyweVR7
yGyfs8bmZQBWlWgW4XaSaPsS1aTyaS+b2Rrwko8V7yoGYSTn6IzJHOCDKwIRt/FWY8iUp0qnEppI
3hrN1tESg3zAOnjGqimnBncVu6NGK0TGryXEtH0HrrsTIz+wje6mwPRHd6q8GG7P/nxr+1tj0639
3Yiajeti3drpZrg3BCJv85y2gdmDlvB5YhAr46q2gUtzlcpoiwDTPB3KLajfh8GRDj1HBEZ1oqLj
ZW88wJ3dTA/Zc77VFScrAUV+wQICSep7DJ/7mAI4x9gYQKfhzQa9JLR8HD3dHm5RfgP7TAVQuuYl
OFOgyrMSgLJmpMho+R6/GwOJ33MEJQEXD1gWpJ0Du1iDnA+HbzrEW7kwMaEP6CKgkVe1ZolOTITo
k9fEK+5HAFBd6ZvJMba9dfaMt36X7oxjFhFuhLk4PeHY1lYgkaonSk2ig2Dlx/woA04DMD4yQYFX
DB5s4MnytFS+iLVfpfL+/8if9+Vbfmrrt7d2+1T+BRigmSX8z7Xgrqjb8A1acPtUQ9c/fU8bsk/4
ogxB8f4TFA1cZ13XVU3QIfy/6EJBln/Cn8DbBoZoGRoJaupnVSjyPymKBB3JC2B6Bkc83vQzB7Qg
/yQIInSrDlEuq7Iu/xpNODOs8fmqIkIhCQIITUEGPXOpBC7Ji8FXhkPC1ZLJc8KjllQgRMt5jVR5
PtGwRnXJh9n6WRt/1L4sovGLEtJxTU1UwXivi4qgqFD1M6Hd6Fou5cL5MPVdb0c8SKTDCozTn1/l
Ivtnl5FkHX6VLsFswNfXlxHKOD1notAfaiHMN2GcuVMYD2Y6yaIZc0NPwkYMtsk58YZcP6lpGSxo
27nXwvMiFJPBg6gbuh90qjPtVOh9N07TWB/0ou1duUwM+1wqis0bPU5koySrLOORjgwDtN9Uvehx
CXhFpcJI3USoFaKo9bjuQinZCq0QrIO+DJ4ltQ8XZmoeMcE4NUNWRAkqFAsCRtuvZ4qfQjlWBTk/
xFIe2moeI5KUB5xzzjPFhZHQI+g5NTJ4eqpdxKH7jJ/KByEMY5rJ02sbBeFLLrbSLubrapX56bAN
/dhwU1Hr7PYsSU4Z6LGt60bpynx3OKvj+V6QQDWqK8aIZRB6mrR8/qjGw+nXbgJsbUy/KOto2hQN
dbYEeTZyYy/J6UExEnlV5cJAtUmJNvw5aKhRpzzt5Pq8k/3sbIX5yNu5Af6hzwfBrLuvNqKog0dX
kgVVFEUDxO5fT2/RqGdFV+LkcM5bcZ2myl0ciLklndXOHrW9MQUo2FLrJRDjbw+AohuQHgYP6nlZ
hKH79XVb3oB9mWfB4ayNIZ104S4NOyDjxQpn+nFjuFEbnjRfQVI9SBqTq6ETP7/zeUgXfbIGZB/j
pYScg7U2O4O5YBR5rObGHtyNjaMFHFrKqkm7CmANWrqvpY4wnuQg3jfiiLQ9CMabqPZtoROR4QZj
2DqRqtDW+3Q8JrXuhlHmiDkHnNVWuG9TkbaAAtQmYwF25BsBpYDXGVUVcDWwZgo/cw+SVi7PAyca
+zoytNOonHurHSt/IfwisPn/al/g03UJ86PLisBr8wiDOBRFUGj6tI/izBuCjnMGAZsUJbekS5TY
Ftp6eJJK+TnqgLM3qSPJOl1bEMbzKCDPwyNRZF1j6wOfjKmnj1FALqnDvC8mcZ9LPr9Tyn7DT0P6
0LcGOpL9EsTLlZQIGxHskCqMmP5ZUSoV9mep6dg4VVI8KMo2bIxzQduERwGyrtSilyt1Q3wtloH4
3lZMl8j149TV0tvnO+xbGasKuiZr8Bt1KDJem8UngkJWlTox+D0cgU3NRcFDI2FvxZosA0FRGHtU
xXdGvAUjWbHVIlnzYf/1vqf1Ci/ZcpiIRB5D4VE5q80W1Yg+IAulMdjmPj8t6YOv3U4oPlWUFPh/
CprINdmYE7iIxpBkTd63eynOqitRUVrnXPkaLPJEsDkuAP57n2vrfCyHm6woMYGZUCDG3+sQtVXc
NzSR8xL+RBa3e06TKjvMc6P/cmh/mHV/17C3/7lZZ0dxBKMtb6N29F7/6/Lqf8QzNP0nUeJlxvn+
P9abJv/EfHoNCkbSoWZgxvwjkCGIP0F0QPTKUK0abxjYCT+bb5wo/KRJqgpOYl4RZRYf+TX22zy0
oMEDxm5CiEWGUci0y9fHt9LTqFXQMX47ShXYILlzc9+HMvecN7WyD6V82idqNpq+pnc7Do2gXjKE
A3xPMT2M7TmMFiT+TKgpbDwKrDuBh8kF9t5vODbiIAz4M6fdymIsea0MZOYmjYu1PGkG6Q0dQM1c
kdtTLOpWGqUBPJlSpH6bZAt8sl8L8ctAdFiYGhZH4g1tbv75kyj5udEJt35ep1YYhEBOHqfG/bBF
vmPLziMquF8BNwzrEksJHT9PG4ypyvmt2Pu3nJ8G4GqX0OOc8Si0CjWVJH6rO4ParmXRmKjYTOe3
oayBMOArmqfGSUylpE7tTKg6Z8jAAKzmU+DpZ993894QnbaJUtPP+mGtptxgJ2Ul2wIfNjdZW2Y5
abLYsOS8ruABikvW64wCgU0gXBZY57zIPAN0t3y9s5SxFbNelrVbLs/XZceZSlTvCiHaVDlYlrXc
hcVI1FExywIZ/TCi0tibMuIv0VC5YdBZMu/bogR46lyDoVvYcay5Q9GfWkUhJec7nAiuOG77+YJ8
u+xs1HCZdPhTEn78etSiHxTSuW3121BUK5fTE4OMZdUsiPLvXgWWHJSLpsG0hFT4qDSzwS9UPcr1
21HpFKrF8OXHRhvsz+9lHt5iS8C4ZCUYcAKMSHl2mUCqQIOdiuEdDKDo2AmpGqBFf+hhLwcIZdWN
XPG2pMfR7ViXXWEa4rnehjpfAy0eqgKA67V4BjJ2WgUdKSc1K/6bui/bkRvHtv2V+wNsSCIpUq8a
InJyOj1F2H4R7LItURI1T9TXn6WsvjgZikQKvm8X6C400IVkiMMe1l577Uh7Zsl2fucru+EAiINH
44gzMbT7cjfyoi06KnR8yuqaRB6BmIJjOr5jWl57ariHAPqkhaHgfPuip7q1krQn8Uki47sZK1Xf
N45VB1bJ+yCzuR3UXdZFWVZ3x6Wcgf/0jfPJa/LyG3eUCUnJMQ+lTdXBVOUvhZjlZppLYDC9m/tu
OvaBGVz64NUdOQzLuIRZ7doHM+gSM7d764M2y3znZE71sHPMr+4fxrY7K/KN57bZv1IrxxkW7J8V
F9Nda/AlyPx+2oLlR+kC1RqqAiOK5hqC5E3evitF1fhVVbCPJLNdYJwJCbjK92z56jr+Nz6FARB4
/RxJi+Q2bOgzE/JFBYzPCZND1ifnxGHJPRBsSBoTi97LGIG5aWkVwKy17zrdDeHbO3IZKP13ZddD
Mx0DLsG3wsI9XQZXpVly1hIjEW3P/SRIBkQmJrd95u4Nh13D+e13uuALuXhs8OXPLXAvv3OqckpH
vDKvyNvAq8QSDhOFAEilu7Bu6tl3VEN3HMea9G0WXSPXNedeY4fnutuLRde4VXqVJ08xsqfHVNUi
KCkrMeC+rL6K1BORYeWZDsty5OM07rzY1XBsV4c9cfAfQTENa5PhZPaSo2RVw34lI0fyWXxPrQro
tsn3hrxuyBDPZ+liIjYUeaWD+o27WaoBMsYLrrwTGdsB8jpN5x4ToD8/x2ZIbxo6PYhJiht7an5K
bzEf4sG+WdqZh14i/owW6gkudasnqpzvwxwvN6Rh3xBXicNCnME3Tj6GpijJoWD5n5x56pEyrwns
MseoCGBfSCPj9p4P9LxYxopqL+t9YxwW2QMR96qrVGRkW98vtoVRS4sbMTE8NYXX3laaQPqnUvqH
qTjk4i3e31bthMkVXQ258jbrApstmABlG2vH1L1yIwWH82IUQaQD/ALH9+JydILPdKxncUIa5R2c
sWgirWPIGjUamk+uBCNco2Tx9qN75UYKDyAlHvo6vxwVtotFM55YNa1d70Rp5T7Mo0tDW5TkRsOW
3lbGYALV0tQh8jDxPm6mYedBvHIlMQFXIoSSMDx0q7vQc8vQvshxT1Jq+YN2+qeaJh9sXVU7keEG
GHm+ktJZAwQqLfzTXg3fi+1tVZ65nkm9k6uW8kkO1hBSRQHsux1o9SmfDrloMYVNGhrkY9X5KJqZ
u7d3+zpQBhRMAVAiVBYusv9NoDLrbpoIr8ipqDQL215UD7q2m2Pe6hmZM23vnKWgD45RGHEw995h
SKv0prOadAfteMXY4tCB0MCBAyvbtqipfGQzr2pxmju7ODKEpigMoUSYGf6xXyw7evvDX7nboIiD
B4rIkgIE3ji7zExsLEsqT62aMX+elvEhk5X1QKhxj0VmnMfJc3+9veaVg8VnMWRhcGYWDNE2jpqK
qV2YPclTZ6WYNazKH+2cyx2n9fwqL42qY8GNYO4gzhTXavNqezF6Ou8nda5IPfrV0gA2yqm5nSbX
/RiLtruxqTffJbqBP2s7dUxth9zVyusfNfoco5FM9d5Vv8SY1qsOF8rhIdmapyJJvLzqhVUCc6w6
hBZDWUYu8JCHbJyW0M7j4qbnxjqmlGKKlWpU2Cg53XWTPR2bPjU7x/7KfQfcDycgmYd4Alni5S+p
KrvQSVWpM8D/FCY77W+8qh7fI22NvwvujJGaRXmsOPNueKrzu3IcbeBGaX98+zJchzUO1JAEsGUA
kvjvBo4Fe8Ry5rhRZ06yBqMv+tz+3NgJUuGuSEH9XQO+3m91kp57OVR0D3C7trMMCSljCPjYmixv
rgmbofYweuN4jvNmCaraodEEJDCQrGsCRKfTzUTi8dyoAvM28qU8ov2t+STtUp6zmM0Pwzx237nr
1e9z5iSfBmONvuyL9q5b4AvHstNPqpNdWLop8Qc3Fv5o5vamKZwlyDW3j5k3lH4JrC7MinYMATq6
O67k2qQwBvgKGKqw1iex+US7KlJT2ZY+N1U8h3VbOEeZOW5YNd547GZn3tnT6/eNxBqBKqQZxQq0
b245b4ulq0WKI9Wj8ltQuo+UpGzHQ12nYwJBmcM9vO81s3zuWH7hN9ymKIvFo9XZuEb6ScPvHO05
iBGWOaKZoWGzzENkAaF+r/mUHBvV/ZqUY/2T5YW6lb3GNBHZqZPDabzz2669JzJ0jJGHEUf2cxVl
VbogvXbK/OyohIZlUuVh1Vb0g1VDAfBv3w/IO4iTESdgNSCvlw+5pUM9O5VTnhdTlk9TW9U/B4Ni
vdQ1pp50Un2wnX44KA/8hLdXfsWGMIGXyygezuo2N7HkJLnsFqcrziDKOZ8SDgNBxUwiq3cNpA+n
6mcW2zRA5Fj96kEaDIUkUMnobPuvL/iarDn4fNgSz7LWC/niJjQTTyEbwcszQQU1sMcY09TdKhSl
V/udVZc7W36NxcAAchdQn8NWrNHaOE3u6CIrHY3p8nSZzz1fsmOnrf6+px1qdVKMHxp7wkPXLRQD
nAzYyqwb38oa50HMBZQLYo7MJkV2XKaa3Kl6RmSTTRjrU6jkXScxkVZhbu6Ra2nCTMeW75lhvqdu
3X6om0ntfM91DAArjq1DzypYSCDvXG5fUhVWbOsuPXfzVHzuMkzDtVgiw7FpvePodG248EzuRVzr
Jl36Z6AGGP9LsY/451axQFdSqjQusjOcZf4UF7a4q+LROmb8u3R/tlbZRppk5j5b9PiYlaLZuTTX
VgqVYICEEg4Qdv85U3pxabresSYv08UZ/rEPmQHAP6X1uLO315YAq3A8S6AxqFdsc2ejLbG4jcjP
zOoK4HLzeJ9ntTii2NXu+PRXl0LkankU5UXX2lqC1BXzNBTFuagq7XciBhkqo18y7oqdlV6JrcD6
Q82G27C/iNrp5Y3xFHEJN7k+T0mC+WbABg5kaDD0aKJg+uQEQw674SsRtTyY3vRPQz5j7N8wpVHr
MhV5pTftpNDXp4lqDgADkPsogit3k0SofCYtyzR+Udx54MNRN1g8speoX78UFxfFlZAH5fj85wLr
izsj7Ng2tT3p8yhr9TCKEROJ5VweuirVNx4beIjWkWnnol6dK6glqFuAWQdeCgDO7bniUhVLKs0Z
NabfA2/Tw9jlTjQnXf9xx6JfvUksBYoGgmYwNVBs3eyiZSWyt/JqOQ+6UNHsemMENBXwd9KUdwkq
4z5ZeiiF03l4KAdwwYaJ7TFFrk5SPjsyPErUQJ2r3+CscamMmXOehIPxzmKc/RxV6513eXWSqIxA
IBqgsQVUF+WRyxsMGKgpLULr8+i06pZ0Nn+wZjOF1HaXQ5JJMCibOtt5N5eBGCJMFJqwr5YQK358
RTzNbTa1g/S6Lwl3H+wh+9BN2eTr1D6pUv95+yydy338dzGQR9DoJ3Cg+N2XX2iY6bVdJ8MXvSAi
80XPa5+4bX50PXAk+8ozx0L2btiAJhV5rc3eJyiHRrkg/BZOZrxf3C4JrSx2/aHsMZg7Hbtjrvs2
0FLlUTuY8aMtCi9A7oRhfKWRx4Z3PGi6bt7xFc8Nd//rK/AtkiKSgmcHIsLwz429UXhyZImX4WRq
ou80yUHHxx15FxdgKcpGOZFnpjGgpNFRlQAloQ7tbkaFkgjjhTj1wlGRxVgdlTIbI+nCh+a6zE+W
KMrj0EztI660vCtmLqO+m/JPBAFsJJsGYvksbv0M2r/3qGH8mTNvPjZlTM9OJpoA2Hj2j/TA2PH7
GUrPdinyO4bJ9vcyAQF1SbkdqcKqD3MzQRfXBq749jFfnTJ2BmIT69Vao+BtEbvoJ9s0Ugynqcug
vOD2GO06Yam3V9nE2usBIMrDpUU+baGQs+VOOXGqvZ7F1smM0sH3GwwdnUsWDmM1fl1MDonuRfFD
0xJ+EytZIAUyCmFPoXwH+cdDp1t9aAe3Dw0V9c6vu94DBpgYcQQuLkPSv7FaMiat0e6EH+dBqpjZ
EOFGwcvbebxbGYnnPUDJWYArB7eHOtPlgyozUKPUwK2TnBJMnUQ0GrJx5TgXrHiPUjW+1Y5TGVHa
1wH2pfluOUT6CzEYGMkttNjywQ3iWtqFP/D8EWWGaWcnLpPZ9ZgAn60QA6h8gLHdzTthqRotJYl9
yjPOQ2RmMiBqAqfC5mPAhxKSyA1PjwNJfskOz+TtW3LpqP5dHcEUCmMofK+1p8sNquMqJZWbOKdC
ztndIGZMlE+AUep06XcO48qSAq9CzOpaMKgW2OYb8x339dLWRUlPSCb0gQ02JkRWRRnQGiRCjbB8
Z2M3hf3nb0MKjSAO0i4eAJzNghRV3xmengKij9k3oxm9tVpav/fsDsr8QBHCzOhlLezTW0IWzHlt
dXxYhjx/yvN23gkJXvt8YAoCTDIElXCUlzudWjlR2Bx6UlNtQgDgGFeKBMinIEuF5QBR+r8+Wdx4
wN8CNUUkC+sLfBH3OCWEXvNG0BMMfHyPuBB3qJrtR7C29N5Or6/10taj22T1yTA4FNHc5pnxeJB6
HHCHh64S7xcAw+E4kQ/ulLjRwibxmFq1dbZEJg60KDAW3GudAFmqAVDTfnYqnEL2E1p04HtGhNsY
PTrbew7p1d+INwaeLugeoJ1c7odb6LReYmafptFhHxkt53fo48Ag5HqA7DpqvQedVSKsxiV7evsk
1p2+2h0PJDH073PUcTYnQZAxJaz0bNg6xzlMuYO5unJpb/96FQAYFoJBG10cAIcvv4+LheWLIuwk
+9T2MwkAtUuLfOeoX/kWXN+VrIE6sosC2+UqYk4zL00KfuqAVUasKj+3bNzDgV8xSuhEccH2pkC/
gIJdLmKTtrLlZPjJdlP3NrEIhjAPVXnvglT94e93DaRKEMFtGCax1Y01OShBdMFSfZliIHuJUmVJ
9bDj8V+5e8BscS64fShWbisVSL1SaDbO7KQQ6ByXRIijrjL+YTJTfm+qen6oLFSqaetZO+dlP9uV
ze1zQZBEVA5AEcyOzb3PKrfPRuqykz3MHpovYmIwiVn3yY+iwK0HebgkNCAge98rNWZf2p7Ij0Cu
mjtXK/kPQuLmXV243tlOk7YMltGOf5CyIx8Syuv3fV3IzielOPTMQk09a4SKg7LIlp/agCcbWNzK
fyy9Ke3INUrLwMld4AKo1tYP3uIkB9qMGZzAZOfQV6pl+8PmFBAkUVzel6PkkRRe6cPaIx01Q1yn
Yb/Uc+t7bc//iVUsfnrNCG2KbqFp5ie8N/QhTRVkn0pAmWHBh7qKbNG5zX1bAEIPlGytH4yO4hdh
fc2jeZkxZzrTpA9yu2qKMEnz7pNhvfpE2VAz1PCq+Cmm3bu0ytFv1FNTWrdtz8Q/IMGiAKPqbooQ
ME7qmC0JIOPM7nIMbomr7N7j+eT5sadGDHYu7f4hb+K69BuA5W0wW6X4ZiZcSzRDOhJcRGWD/GMo
YuW4GLsl6oqZdmFT0eKxQSR2XHtbMcm4Y0sPnVvenvtcAoNqUAFPD1MzwZ3yOS5/LBrsoB7lseS2
nBzsX0wN/TXOPcAuhHUwvl3pPjYo4alDUQ9lGwx6mnO/8rKMAsiqWnjIJbXUjWMN8acR21/4bl6O
p2Qk7h9vKMiNoln1fk1RbmFVbX07JmX7i8ZaJj7VNUalzGR0LAxZiYcvTpHNZYi8pP9SN8uEQed2
P3yVs+Q3mTNz2+e0Fb/ytFge6Nw1qDLXokdsVmUjNLf6MkfYrkz62Nhg4vgD4U0R1Cxebtm41ChH
s9I8tbo/CjMz58ZkSLZ9NsRU+3puzdexIY4ILMjN3BUJrWZ/rngPUkKWoImhcOLmm4P7iBzZ7qGi
pm3eBIK0LTrCwIT5M1Uz8DRbFU7vW9ZCz7Ju849xuizoWMsUe+gTy4LCmslEHjJ3lu+dvo4DNHGk
X22tae+jT9w9JH2ZDQHg647fVstS/Xnbkl1mx8/RDjw9qAConllr4eDSaJJlJCNgTNDo4Fu+zJUB
vc1rZgK2Li6/n4PXFQ0lU4e3l30lxOaotAPLR4VsrZVtPEIhunpOYx6fXDnxd42Km7NXEif3R97+
aVqOYSPVkEUJCnlhPQ1NOBbodUy0wz5IrsrIkTVICA1yPzxJeZdXVO14xu3OoJYIK46uTdBP4X23
ucbQxg6tyrw/5XxUj3nSFZEcMxGwpUsCNDXYHxGO7AHOry3K4ZABHwBHBLp3eRzW2jxqDXpEtCuy
IHME5OoSZ4ks6Gp5BzGWv94+h214uX4kUEHUKNdDAPP6cr2xdgYzk2Y8xUtzbCUy+zkzCXhPdnsD
KtCOQ3MuUSf0XK2RBlwZ6n/P7cSbz2tY6Ro68vE0LeN0YO7ShwXYrO/TSo03GTxD0PEOEoaewlA7
ncU3KXK8IG6pE2R11oQ9SteBSAsvwg9vohKlxoBUOotSlXXvvFiYcBmM2fGGrxwKSAtr9PJcVNvS
FljRdV7K1XTKHeMeRs3kk506Nh57ad84zRBH6UT3uH2vnAxdIxmgrigjgwN9eTJAXqaib8rp5DVt
c2MkITcjGH4+WKdTmPWj3gn8X1lv5RDKtQODgiu/iZ7GvOg7mnZorEzcjypzGtRAEx7ktXeXMDSV
vn3v1l//MrzARZCr4j4A7LU9b9uKpvslnYBQzaeuJUOUpmkSuF67l2G88k34HoBJiN4B/j2DTS+S
mZGClp3PzXwq+wbDnLjRd/3kfoQ76O+Rou893leXEzgrtJ7ZoLVtbjfCNUskyplPS9bqADwTdBOD
BH1rSP0LwFO185pe2UOAZODTIEoD8LdlL1bzOE3xUprTJFl6AEUZrewisb+8fVKvfBS8g/BgqMEi
w7dd3sPSJTJGO5o5WT3/wYvhyXPG34mZf4t5LHdy/ef60+ZagNpLYY5QVfau6L1JKsVcgzNy0sIM
oZNnEOASZInGDDMajKjTmwkRl08k2tvHUaFBuKRzKNIyCbpC0aC2eBqWiBHe3oNtZgHAzUMZBFAi
pgzAU65m7cU98lRB2tLYw4kk43ioZYYOe2LJG6uCy397qSv4YV1LwEqCi4W+FbZ9hyjJcaViOZwG
hOA+qNrkc4OuvoepduuIdhWoCnQGA9QbMZLTs83dzLr6GC91cdsjEj/+v/wc2AUg9SgDoQZ6+emF
XYGgyNIReABpbhcHrhcEjelRp2z2zQLsqRsrCuo9mHpOPKMpfViacLDL7kYN5bRDmbqCup93Bx26
641fg4eNlarHSieiJ4CHwa++t0Z0WPAZoawHGkLoOovyWapLDIQoJLp11Pg4q9g7NjJDLGsmK2jr
NhJLr48eKriBJLnzvlsKGfGak8ehK4u7pXAwLQ9dTwGIf3M4pGnu90U17RCEtrnd+iEw7IAUPAFF
DLFxvIOnx5GABHpyiiULqsqjjzlDipWmveXL1MMoNZQQ7lnGTm+fKH3tMqMtY7VTq47DMwD84jJb
I23hoavxBNMB/QBils8gpSI8noX1iY4Zhr21jB8m3phj58z50Wjvm8pi58Ow1PW54pmICELCgCWW
OgILJr6X2zxqJ5S6JSUEvQgebi5nXTi0KTu4zRgHlcu1v3hp9UUWg/Q1HhuqTqr17bQd7m0wDn0q
0iWqXYYxn60pnojjYGBeZ8xOXHdtNhkIWdBAAaADiv+WTJKnPeiykzInLk12WGg1IfFUfOd8r3eZ
wWAAIF0bFRBjbZgxpq2sSSt3OSUcYhJo8YRyxeiVEBqYyI7JeOWDoCwCRgTKeGsIv7FOmI2CjLm3
rNMAHuexW8bmUEgdh2/fm9c+iCMaXsnaMM9rz/xLG5igKItMPLdPILxIn6PryV9q70lqe3f0Cf7S
pRMAPxrsW3TZIw5BbHq5Uk5Fi/pHA/R9tG+s3G4C19YfasPvXIB/O5t3/Q5R2rZBCAMNEwDflWkH
smu3cUdPuZsLnyQG40eM276zbOB7EIaxbkxlVefCWvYwlmvHipXh7NCiDL4AwPTLz1xIOyCHT+nJ
mxLxuUvYDzu1rF9EQUHCE2LaseSvnB+CEhCNUWkFcP8ssvvi2XeslH2dGHqytGWHVqugiCIhMeAQ
d/jy9lXBjbg+QoRd6LFjuBVAyTZHaLtz0posFqdUJvddU5cyUm2fPPQVwCr0gzDxec76Lg9YTuSn
qgdrJJzsMZfBMrnlnefE4JRXBkHo0DMEvciBOAU+INE3jjnYZYq83sq+Aa5NvrQCDRo3HbNbO6QM
+WuQeXUNbFzrzG9aOdZ+X84pDRJVTS5QinLKIkYQVsCJMmp8ibEod2LKxUfQH+G7nNrzO1QaT32v
QFM0SQW0F6EqKOnkpu5E9VHEuh/QnJBytKo048d6Kio3SCZsvO8Al+pCd0mdr25l0xmaMsb+mrLm
48TnHOIsTp9hHrAmxbeM5dlwlGg16P0ErrQIq86AQ18r/LZk7sitgx7z1k+LXoWiFkiHB6v/wDNQ
8YG5mNG5YXBhnwcE6r9QjiZP06wXDN0UdfzFmNyDLIxjjWnQgLB1ZzUVwqk0HWOEwpaGiEvbgpPf
gtyPKcXAtGy4nKJnflN5NaoMig+AUnJArkHuTvMH01gA5vii6hXDSfL7Ac3goDNW+Td7MOQnrAMA
OLSB1bCnhXtj5wvsvlO7U+fzKk9n33My/R38IGAxK+7Jg8os5FsJCujntmE5mtpc5ZR+Ac8JRlC7
dF8A305gvoM69cmy5uS+J0lxbE3Sf+osuXy3BZmgHpSWNgaNFKwF6MamxT1KUD0zSAaZfo7cDm2Z
X8pFNfF7PnkLZssmc/pIshFaRW/f+1dsCXpnwKdAnRb+fVvPsIE91+igWU6l6oJeuPVNmefy0KeU
HAzemY/ClR0KK9t52tcOALOxUSUAIo2YEZn8pSVpFK+KOSXeqZnBN8XUIRcx4m5vxLW9WttdAbyu
FVFQ2zZvumZLTMaqJyeEZ/0d89zu6EwVCSS0oCLN2V4kfG2wsB7iX7R5rgkc29jHqYpToaB+eqol
eMtxpWZ/7OhjhybDw9vn9krMjaVQ7kLDk7e6gs1Sdozm0LkV5KQ6kd6nnr1ENhDN0BI9SjsNxYjd
zEs+Zuhgft+zvvyT1IkOPT7RMHNrsteWtsYGlw5w/TkCGm5wDmv74eV5otI3IExwyKmF9kDYp416
6trY3KEnAA39NG4OePqQuGIJVI3cGiAnbnfQL2oPE3jtYoH4CS+MLBN1m00QY5ckV4mTJGcI5ebh
wBYAlfEQ7zybVw4anhBJDxhA6ITYtoEBpW7VJHr35KQp+ntokUadcZyjW/fzzdsn/coHua5gkF5Y
Oy+uGv5i7hpSxYN3yoqB3TpJmYd1CtL526ts+lxWmAskDcAoUHawUN1ce9dfxkram3I55ujoYU4a
+9aguvtZ6+4AE2wix0Phwi1TJ1qSCQO1qoWHbmrITvlww9l9/hErYwQiF4h2URdbffQLh581bZ7T
pE3PcTqCy9+JMn5AlmMwDVyxKgF5YXWTTqyhfuAN9ZcFjbT1HV6B/OJ4BC0ib2/KaoQ2lxqsZbSd
oEEfo/q2YXeTN1YSpxWaGkW7OAH6q5Lm4Cw1hwwXiRWN6mLorbuuSaCF9rdLo0gHXy4BJSLz2bbG
J46c5xJ280RsdwgValYBqOpe0OX6W97R33PFSPT2kisqcvm1EBrwVnkAEIjhCjbpXUYGy13W7vRm
NvR3ASrw2tnQNSdIEBIwGOJmpCgheH0VuFw5mBFfgiW2E9te33a0L4O7COYrCIwgTF7eALcaPKV6
B+3BFktD1mfdHSPoPnj7U18BbS6X2SBEiwviSaaxTOPVqFRBStUXMB33onHsJ0E0xqDPsv2iC/Bg
nbFfQmQswi9ylT7WrYvGv8E0702TyZ0UbMNdXV8AHiJcI4rODvzV9hCGLraXQVnkRBy3OuBfK94x
C9UXnab1Q+EuXpSjJSlUSrdBmQyYXU6W+Ttxmhm9yBlG6yRTspN8vrZZ4NOudg4sTws18cszaRsv
XpJxXltc6HTM0ZISxWucSwqTBZ0ZUXIpIZPfy+k3GMTe+5pNbog4ETZ/ZjRgsiv83pPTXxtG5G/P
VSD4XA/G6/JnVXHiuKgwoQw00skHXKrDGq14O69iKxqznggyxzVYQWIAksnGoaQa3Y2zqtFHQHT2
mTQL+eMopzaRauzCAkfeziB81sPfDnTBcNS4HI7UyobEr1Oaeb7DOg8akrL9QMAWEWFXK+7b2Wyp
qI9nsYM2vfZzITSAjUF/C9BqvrHjdhoLt8xldqYml4/LgvIcMXnyCOsOJYUFBBkqSPexS2N1xw0C
htSM+o5ZAiqULusOVWPVR8tFDzMf2izwFjUO/gyiws5Df+1WAXOG6geqada1kJgRgLpSZ5an2iwY
Ml9oF3io0zwytNT/TOZ4/JXOLftWJUUfdnaP2J13Mwig6HZctTLQrMsr4DjAi/6Oqr6+QRhcEKlQ
tgLcBWnay4vFlmwgLJu9U5+jlZKXUxkmjEBku/LSnTu8adb4dy0Ecc9IrctwcpdrKQLNKm9Y4lNt
SX2bOy3UIlk3BeijcKNm6HWQVTr229Qsxy7hkL8s4uQ9eAMTOpZdCHyKcgpmuyW+NaJLsCtTDLAA
GvGxGRzjF4hgvoyN7I/cmywwIiz8ZeirRZ4YSJAkuji9bVivzTdKZRQCURaI7qjObuxqPaaVBfmU
/JyDPHEziVTe2VX14+1F1j25dFQr0QuxpgDvHFHLZs8Yi+2ZTFZ+TmfH89NE8xC45xC2tjR7Yfa1
UwT5B2URXAMYAZBwL8/HyVRpSBLn59pOXb8ZIMFHsrJ9aHXVRxbexg1BTPVQ1W0bYsSZdSfieQSk
ONh+CvMVJVDRfY9WSzuS2u1CkWRJ1FEvPnKUxz4l1rLbQ78G/pvdAd4PepoH4i1I+Rt7Bei2SOpy
yc4IG10QnmNVfNUzdG/XYSRTvtJNmvfgVtRnPsAVQ7c1L27HtptBkGEGUrGK1Yd6rtKHKTbxZz6J
OPVLnumPsCMzEFC+5Kcxjb0Pk67zd2SGHfIhXAhCW+nU6Uf0VVho3c8bAnbtQOOHzIsbHdhVD82b
pOvUD+CbOgX5UuGa9ADdbeyxG3paQW8Pf+JO5qXukW6P+lPLZIOBY72x28Dt56EAau6gbwqP1yZg
PEAfq7SL4ZvVJCWoNkU/7nWwvbadCMFg/0EaXQPxywvQcU4KuMXszEs7PXhct2ENVOrnlFdphLX/
loW/kudAiocaFJCXlVZ+uR6JHdTDGMnQ+OO6IW1qFUooIwWMtV7kGOjRvv2YXgn8UdJcC4DorIAF
2rLXq5mIpbazHsodnQPgxkjvnA7CfB6nMW0igYL/OzT0o/FXFwUB5cdS0O4ZyyLeUwC0rx+bB3Ab
oiYo66PC4G0eNv4ih9o2Gc8AVtrbklnscyUn71BP9Z2L5qE7xB/8CW0DGO8nk3+aFNxt5YG/bg1t
e7vYPIksg6fmzfaEmBkqgoBFsyiblu/IevSOetCVGQLBEe4BbATkZjZkAC9PSoJYPhdZDw0EjehR
Ad7KF3/S/42I/0pi7f83Tdy1Uf8N8bTfv363P/rfv/7Pqnf/u1uV75+1gcvfeP0vZdXWv/NfZVyX
/gdwIFotEOqtVHqcxn+Vcan4D3wOGO+rQALUb2Hw/qutZlv/WXNZSMsDrsb/WEGU/6uMi/8H/zJE
58HJf6au/I2y2iZRxB9A/Inr+CxTD6X0zcVd+WHaq8v8ndWpwJZ9lOTEHy3ggtrxE+/zi916+teW
v6WJ+7watI1W1ThYemtz8RZlbGKyMX9XkfGmHSjEs3bgnI0bX0V3YfpROoHQMNrPnx/qizx8HpsG
VDnN3kHm0QlSPekABeXdqc2XnmpdhaOAsTKVYe+upn1pKcjIZdG/q3lR+/nAWdS0ejhOQ51GzQJQ
VjY22wuQV//3wj+uqyI6ATkAsTFqmVu6Uq9KVVdoc3rXIQZ6sOPyTy1MEebQ17lty8kgjGDJLXp2
s9AsNVgkdSrnoBzdv52i9e8vwfWjwMxQAtsOk/UcOhHUdNt3fankoVoqG+TF1v5KcpHcxFMPifXC
YQemaByiXRDVOC3S4yTHKmys0b6d5zyPTEHze8HXzn2FeKM0TQ0JkPFrVUIsfKgm9Pb/D3Vnttu4
kq3pV+kXYIHzADT6gqIky05LdmY6B98QOXKeZz59f/Suc9IKuUXkqauuwq6NjcLOpWBErFjDv/6/
ggheyUCEuZGp93cmzaP3vhTGIY3noiVCsM13MiRlj9ePqejO/72+5dUkFoQvWqjxpnZM6MR8/T0h
br3TjOFzwQV2CYapUAZtsIthqUIigPn4zLfCIwPFQBd7it4+uCpPgYdra6nTRzD3xReq7dODD2eG
Z44m7YGibw/Xf6/w0vNzyUXIJzn2C9WIIby8WT7B5oDPv4eZwtwPVmftRlBO1KUHZ2vUNA//1h6D
diSUuCYeYFqu5+/HXGVWNktadC/Fz1WsEeVE9DQ8OtwrhsSckJWdWxIy5UGerHE0saTfAoBedOLN
TbEhmkFK3EYkLojd+rbwys3Pv18hrTtaagt7BtSr5yssZckMRhiU76N2Z83huwgtBDrYdxNEsdct
vfQpzm81tC307XDpBE7kk+em1DZM6mRSo/sWcYLoffzROeXvzFvOvPIlfpe58j5/N57UvbUrd0w4
/nLuncdjeSwO6qmdANBujN8DMqKnyLv+w4SQ5uXTv/5dwqFKgA9GFdMK99pwNykJuHtzK9Xt3h/m
XRyhLg9OPA5XIpML983YPyNnDrRQND8YwDv/GPosVarfReM9YLzfejLtDYafVr74xW15sUF+AVSN
e6MtbvbVE6F0TSnnGvTdJjoWil1vjA4XpD+Mya/rX1AsClPkXFbzx5J6bimOQ9DUNZY0F6LnW3DU
3g8DJYXmtBbrX2wWlgg/mSHkNWdKXUj8A+bhU3OhJI/pDGn+AM6cydLpWz9/jpp+m3JJK2ul4rcc
zLOD+2KTqaWl5Ml0vBA66Oms+T3DGPdOSvEIMDFDWlsrvLedD02qbIxq5WlfsycGD1KrOb2CvdCn
zJ8W9/2c7wLlt9n6h8Ap79VkxeBbhxGiPIi9CY+Wv51vn6z21liZxXivDOF4GNjtjZXa88pxvNg6
SNNpPr3AGCmjOIIzDdKiSwejqY5WjxRIyCRBZHsO3o7ZdzfoYMwpwgNkOCtVrIuv+WKW6O8FGiyL
0+8zQ376GFfVUXKiR1lKdq0fobXSbCu1eIYi0A1a9e9XCqYXOqylWQPcTrgOlSUp8G6x0opBE2pD
Bxpzu8aA405GXUTNHjsjv22cw/VbeHHdyXFB0jDYtdBEYfx8F7OodlrgfNMx0n2P6e2tX++tWAHi
nP+4bkmE2XP/lukd+BIUHlr+K2ylXaS1Hmqzdq/fSyf9djgmt9Qx1I9+DvBqo+wZk97qltvJG+3f
KiVn2k+vI+vlj359Gf8xvRhFBYJ5SsFbj4U2qU5jaPczmG2TWNCggDuR2jUZ5PFYvL7UN80tdRoY
kOn1iKEoyg6RNgaSdh/Y8iYeHuAT2qfDdEdnKVGrb9eNiffwZW2vjAk7aEZQ6UXli7E7W3pW/Pd/
++cvk3LLf7jkYHWEbVOtstUiGY7eavC7bVfMCA1NTBhft7K4w/MdotdN0M5fMFhfTOUtiJlIzYrg
mEMPtcur5rlIk/QmniJtd93S5feijQzfJW8o9EUUSs9PfEGfP5vDOToySRTdh2CRvD5EHee6FfFe
4fVBDWuwgqjL/MRL6PbqGQ2UaUEjTvkplDQo7UJb+zj3pfI9CkcwoHL6fN2c6K8wx6AGs5mEt0yx
ihGZXvdxOENYeaK8DUYlPA2Z5lIz8aZG/TCUitv1K9f5jQWSqr5sFwUtIrTzz1hW4VzFVd+cNC0t
3FYZDkYwy6hIWHdVb62cwYvTwfKIM+nVapA6UT07N4ZYWU7noG5OLe5Y1waUlHT4pB1jRUzs4mzw
2ADUQv9kQf3xdJ/b8ZMS+KXWNKcuLe6i7i6Tnf31jVqzINwmiObiZPSxUFkAzOSTnScrJ++Nb7VM
MnCMkciDYEnwdWXRW2oftM3JIniT5Fu1OUjRGvmB2M9ciiyvrYjUDJnSzL6TYEV/Kk+W7M6fk2Ij
oRHzGMF05qa/Bt8r1prIF35VMCrEprBYTQX1+eYEVpfZOknZ+vS5wLGtvRdvXCfuLsRJoEv5H/FV
bBypauzlvBVjSV5aPOi+NLgx2l4DBFFSi1L40P+8fjLESGf5ojS5HNw1UYf60ld75THCQEkhEZrr
kz1t1Mq1jlp808CrEbgdIoHdihe8SOIXcwAgoNYAewI0Qwg3zNkHlGcYNRto3JQPwew6O+1uvkvu
g/28Tw7arXM7P0s/B8Drv4rP19f61i14bVxwHnqdMVjRY1xmkFMrHqBa9a5beGsHQb8Bs1gIh9HW
Or/JmV8MfZ9hgffECw0YZiBY1QIjwnPMR3/Kn4s8WnHCb1wKSARok0GMB2fDRe5EUc9We00aTqOi
INbSPwCpetcojacU+qZXB8qH+q5Onkc52ZqF4w6DwdTISkR3ef8Nau1UZiAygjNKHNZiOqSfrDqa
T4qSb6za99rxYDgrh/WtpfLiMBgIJAway4totbbHiE8/nRTV9eneKBtdc9Uf9pfxOLjV9/5T/ZSv
9REunxxW9sqmcGoaJYECZwhYGTM2NWwHGcOxOaJ3xsP1wyOC8PBuzIOCC+LdJoMDhnB+eqo5oqpZ
KvMpw9H0rlm5me2pP63nPnXzzGveaU/zGr3Z5Z04t7ns66v770NvEiTyNCPYASZ6/Fy2a+TOL3nu
WZAlLEt43jSFznwK7OSk7ZqNdlfdj65EqYh88U46SF50GN1ojwZTVLjRod5nv8O989HOV67m2kKF
J7BpyoAkYZxPThjdquMN4NSV1PQlwL5Y6FIiWeBmzDwID8WsWknHFPZ8mm5lpr73xafwZ18fwgKA
tTvs0w/2h6OylR7lH37nSo/SY3ysPyUfK8/Zmq5/162EFReljpfzxJgpOD8Aqxe81jOVWKsyMvmU
fKLqgNJXuV3oeD5okmt9XUvp3ryb9itrwjYnJbzZUKRg7Xf/09AORrV3GsB9ro6CdOICrphuimjn
ryQiIl3TP7fmlV1hY7XQ1jttwG72O3pv7MKd7iUH88G6Cz9E78K7uXLlz+PKVb3089wax2FCg9CX
qXEh2gE7Hk6BhE35t269S/qb7JBqH3istRVDF8XWZQ9BgoPY5FQtExrn97OrjIJXy5xO45d2F32z
Ps4/nLvifRK40Z38NNUeAwwwnplg3r+s8aK/dWWWEa1FsZjBRxF/bEi+40STP51m1XRHaaPOa1Hj
G/HAsrw/JoTNs/S0tACkTSf51kBcfNxNv8t3+Tt139zmh/ig75ObSt9qxzw+RKW7Ri+ytkDhuZ6G
MFOzOpxP6ZxKbjlKu6pL19j33jQCO+4SHFP1EAUP7BQW0hz9gZOkcx2GZNNUK3HNW2/vwib9XxaE
ZUgZNA1lit9p6k9zlNylk3VTZfLN9efpjXeQShFMO0Q3VBlFPu8o6mAjWdx45xydadcNn+t8y9jB
dSvLhgs+dIEn8wySDoFGF877bFdxEU/+fAwC/TgFuy5+gof7cZrfOZK+vW7rMvZdoiVwWfQLF51C
wWPZczwpsZMbRzV2YNINn0bnIEd3ju/TpBzdus29uV8rObzhJ0EAAdVaGJM12lnCblVT0tZx1XUQ
kyg35TwfJhQlfFv63UmHyWq3WWtu0zzf9fX3XrU9GGrIdNbIPS83kzYawFw0HsCaXoxAmqEGhDCR
xyODttOdOlk7av/VJqqaj40trbUtLiObRXGARsqiO7C0xISXsYQYRhpGNTj5pKLu2OrbAoaVNs0P
durvQ+pVkx9DIRce7OB9X3eIZaxBoC8uCR0dUJeAGXkOl/7+uSP1+5iWaKA7x6iyuYN6SefEqIKd
ngTRSlP4TVNgYGyw70DxRBomLa/GISJYP/rGbGzTFN5LufFtFyHK5G+PMJn2ywgnUm+kjWKPIR1b
OeoCeToN8+zKdILG8Fc0PsFh/E7OelQIT2G70mK4uDWLySXPXxA+dMgEl61XmloDJphOTQWXjpHf
jI7iRbr2QAVlM6ntYWrm/TysCfMs1+LMMSxV/2VScalsMYov7B+SS1Y6OkN96tVK3UxS3985qT9v
xzBU3TiWjxBjKIfenIrddS/xxuHFMmUHBggWmSkRIEHHC5BjWjVYTvZFZN0YqJBJCml5YITfaexs
g1jeof3Nwdv3vq24JiDm6z/ijdXzTXk+HM4NNA6CW0ybepxCq6pPySzJUO9kerJNG6cErOk0P03Z
QFq+LZWHXqnXqhIXMp3o9FAb4PritkjtxEFtow/lLkm7+lQbUhS6jiml+8JKnJNhFfm9AjL0znLC
GV2mCd1xYL7u0M5MIjoKRQvLQfJvCoEPAg6ea2RNUBjQNy/Us1ERB5uZ8btDUpuja5VZtb/+2S7e
3uWnLy4O9nJ1KYsLl37O57BO/foUDciDgqaKvFEynZUbIYLe5OULUbgj7aXJgBVhd/SqnMfcoUIU
xw5hUquUW9PoviRJrNz19hB5+jw/Bnlab4ZYs7exXVd/2aN9+QXAn4HA0MW5eMrmKIe11Jebk9mX
3WGu03w3Dna68jkvrz4F0eUSMDi+FCrFdTrAFmwIvU5NY+pb5g+zb4OfOxtzmoYPSZp0MNN00Q2i
ucOxqPT0/fXdfOsScA8BNOJ2lqbA+W7W+lC1HbjX0xDr+t7MK4bPih6NZ5pxSjnEO7MHJSrpCNRf
N7z8wYLvwZ0vMySYZreFY2RLPkxNyWAek5YOTudo1V5thm7jc+43UixrN+jA/vhLm0xGwGsC8pQH
0+T+nS82o6ulhFagceu+S9J9NPgbRh89Jf00BH/Hus0rJdgS1jeiti11pa+enCjbJLZ+h+b2XWGt
NfkvPuOLmaXTCAkSrORCvFXMga10KIecdMM1fwVUGydXue8+X/9wF6+vYEU4JfB4t60cEzX11XhT
FNYm6m/DYF5Jri/OIlYcPCL4EEhRKKGebw+5UYJML+QZQ70z55tJux1rbv5WKR7aNY2Ri2CNoiUI
+IUsjDCV1+/cltROqZxaIyv6wliDkW6hKNIO17/axdVebEAmT0MWFCOwyHMbCmx7TcuHO4U6wuh+
kzwl7ezaYEpmvdn4SgEh3YS4ch141w1fPq/nlkV4CcWhTpmdSiY/YsqlK6Ib4qSNNP+os+h9IVvw
OTSeakrbFtxtJ3tMmaxQbi/f7+x6L78AADTImoWKVYxoeN3tJBhL5eRY6c6Sgm3ofJ4Yke+yxzbQ
Vl7yy/h/sbZ46YX6hJFbYTdrglP0YirllI6KN1jmvozTbROq3tDGn/Txi5+qX8Lig8HY9yAl7txB
n1SkK0HNW0eKAA66DNpOyotK8OuyX54pRRLD4HUyZslrmmcti1yr+Sk3a9Qcb50rcBpEUDgsRjGF
sG1OHDuu61o5aR9ihCTr5yq6K36m/vtKPwHxuX6W3loVcFmFfIZXmNbk+SGOZGVqkkTRTvBfvrdm
+Q5qxvu2zr7UibVyX97wMpDi/TEl7OIYR2PkjKpGr0Z9DzXIrmvHu3FcI7l+62guSQtAZSIZvuH5
iqoMZgYkE/HMUCVsmMH+4veQErR690lLhpsKGbmVb3hZkiE3JcqT+XzLQLiYn6Lu20FyUrUnGdbR
L+mkIEteI/6nqeG0CbKsPuAOf6VyYm2tRC+2Q95t+7B/B4FQ4foyT5UfZd5cRNX9hJbDfZk0P6AP
jfaR0fSfr2/4ZfEP6jTAHTKPygsoUdhxSEJVxW/TlleyX2YD86+V05bbokVbMmCifaMTit71jPO6
odzK29Qq++1UzR1cNHBodNDWIW0PoVaROuru+o+73LuF5Y9nAhIqogZTaPnXPA9DmaVES73NsEUb
v4shA/J6Y5y3mikhZhqXK+ngCwj23JVRTVtUDFFDANYuThE4oYoK3IJ5ZdrGeg7sLvw5JG36YRrg
QXepxA/PY6Y5xWaes+xr0UWa6baxlFAWpn/zYazs6GhLet64hUFj350g3npK0lh6LitZyUh7LLDB
0uREz1qkzKU7cEgcN/BV9TEOWxloZKjOt0PcGo96qUrNpkYu2Ib4IkVInuEg/6MN4wl/8KjOcK6a
RnPMpZJypqJEyVeq51PsJrZkPeuxOjwmypRAPlV2w/epMens9lmcfZQpa4PZTc3+E+CR7PswdHXv
5lUWnMaBdsbKjRC9Ci1ZABU8wIvcNjMDQnQkl0EDcsSsTrhuLxi3kwpTU9huUKu7fmBEnyIaEi77
IMlDo1UY6mwZejXQtOnJ8ceV5Sw/9/UREa0IVyanzlP0OVYMGQwtzBVFU6y86eIXo0BA7Y43jvEj
CETFUiGULEqbK3F/SrP4GIRQ3EZODPEwyiZZQnXt+mcTF0SrFaQjtwzdASjaRK6BOAfCVqZ9f4pC
KjuTXDabxgbzf93KxUNGeZUCC/kVU4JQswifrTfNsVekCJBG2G/rZgjdvrXet9UA5aDmTv1MO9LO
NxBE/eWpIM/CMAT3MLEuw61CImAP5tgWVUZyqZtuUeeuVUVub68sTzx7L1bozlPe4HPyfJ4/NORz
gNi0nCKH1Htqd7KVyC1A8Fz/iJdbxVpeWRFOeBz5zN6ZBWlqnEKj5/if6T2sySOJs8C0h7GypIhY
IoUSa8idMQ9yaMfkia3vpbF1qorZbdtf9HE3yVyiHKLflM6A75pDXqzJ1bRx5P8Zbkpp7SpcHhti
H7rHtN/4XbSLzr/rlKWIB+h++DBK6SZ3THh6S29OgEip7cY39F3VPjKDuHIlLp4eBmAQw4UAm4kA
2BrVc6s6gh0TraPoAXlxw9lF460Bn5J+yD7/7X7ytFH8WFDhS4FX2E89qxtFzaXoIVVaaScj8+5m
hrpW+ruor5Bhkf4salTUcBeA4/lyAjO1opSBwhOzrqOrJ6oCymeYdv0ycDrAEMy7pVPeab41ExlL
VJRrwDrx4PILXhofRHwyFTBRxjUfogoVU6U99UCvYW3KBti1s2IlqFyzIvgYBP3ANxdyexodprIz
AP5MWqz13N4yYiA3sXxTasairtc4MHg5UsM9aYHJs5nIefkkoUG9u340xDdg+WI8lhAMQhnMQL5w
BC2CHruAk5hLaOU7BtBrtFGk2mNGP9pVTVWtOLCLZRFiQYFGyAPdxdLVOT8jWqnHRq4p1Skwe1zz
78p4ur6g5SwL7yYGQCtzEBYyGeEmE5ubhdwz7ZxagetExDG0iMJP/5kR4aSPdc4JgEb9FDGIH1ef
h/lDZa2RJbz9qf6sRNga9MlriCuJAJTiGd42N5qnFT8vej1ijLNvJbxZWRWakJtr1Qmy1vGQNa7O
RY3pUrt+u/1LSXkKMYK1Zb2vMCwIvdopIKvqlGkfFzWEYrijgPGXLlU0Irg6pUS9IF62v/zBeuZD
pcMPT4a+YmZtbwQXsMjBtIwkQQfTf9cAHEZrKcLaMV6ejlcfS4uYYUW4rzqhSOlK2YNlfFTs3//Z
KRbuIoPdWRSn2Agm8MD2Ny37ZHQrFe+1dSxH8NU6osKcrbnniMUZmu0K0CzEIFfb0SvbIQJOh7mJ
m9JhJb0dMTQfupW+Rgl/4SjPT684+pQ2LKKs1OpkKfFNZQ2MJZwGFabj8vv1XRGDgpcTzOu5iLgy
IypCPeUWGiyj5tqTWmxtejXG8GxN2tZy3vt/Sf76z5V8ZUu4LXbECGZeLKlM7Ww6653SP5lZ6F1f
0JtH4JUR4a7Ukhylg7r4MRguU+1GtqWN8j9J/5gN+PPZhAvTDolTNy9W1HBTQnfdSKqL6U2X//2R
BkBJe4NCJM1yTViPKam100gyzt8sNzrqDuTLLnJL17/aG76ZYhJoIhLahQdYeMeqron9sm6qk+bQ
MSa5hiYa4Tp30Oiqbuy1dPONTcIcETmYOIoSFy042Proxw8c7+orXFRuoiUosOyur+miqMrZPrMi
nrfRSFOKQdUJUcQlczmWD8ljPLkyosi9W/2Y78NHdS3xfHNpMAItkRQdDXEiOWkjVVLDjv1yUs/3
h19m13t6mq+Up98086r+IDzXlk2FnE4EgUf8bQTrlUrHpPt5/QO+4YTOahzCg63qStIaEjZiP0UQ
+bFWnpoWbussXYkM3t6pV6sRrhOq0UPfNri7AXIDlXaeO9vjfT2oX4o08LTCpovX7WlIvzdQlkmd
+La3tH2vBisP7dqKhTfKKhLKqsPioeIWXVDV01om2GV1b69qaF8kpC+n89WahbdKsZNCYUSlOjUh
tH9e7rvtx+a9dZM8+elGyzz6YEW2KXb+X9JXLm749baKutOJIqUJ3Mp4yDj12tR3++nx+sG5zM0E
E2LE2iFBQt2iOkF44HzpZlf5nlRu0jJz5jnBLjNWDtDKvoka8IGiFJMDFOKkjYaXTPdqlAAvzXet
9D/yXH92TYReRkaC94ywFKnVVo9uq6TfKcmn699v5XI7SwDyKozJsi6om5cdQrDS6O4QIDnIa0oq
b7z8Z8dA8I6+1Kh6obFHcjbslb52ZzPYqt3gSsmxVoL99SW9+cC8+m7LDr5aklLWkWQs362HuHxM
fDDA+3IuPEd/QpsKjQQf2NBaTrN2LAS30s//ZRQcO27lFA5P9vh5blaGLcS27z8Xip7Zwiu09GPP
14b4bZ53LeF5mxe7xJBdStGuCcjZctC9bYtjN3++/jXftoicH3k0f4nnvaBPV2XpzPtZOp4fx+/K
fNrkORyShv0egutN1a6BjS6A4/+s8o9N4TVog8gZzJBcOtelzaB9gRnYs7UeavJoVxQQL6gHxUGK
41ZbHWK92EemPUEmQoRL54nSkvDYhYVlpo0qGce2/Kql6B0xlQs1nwe2fvuXH1awJCzScWJbH7LA
PNbyg1/JB61hgTGpahs9tWhp0F7YXbcoksLji88XJ1x2bTIHU/Exqe899bb5pM4bemYjTCqNC5DE
tW6CbbahI/PJuJ3M9zZjQ3eRt9bPuOjwvfwMADyM0CALBDfY+SGupHxO+5mfEX1qvg2/a68+NO/r
D8Gj9b7cpt+6Q/eheMA4LTRvtf395ga/Mi68F9M4zL6pYty8HyiZu8ZOcbV4gxZJf9d42cO4T5+K
3B1/rRHkXJ7q5esv2NtF5FMFwXS+7ETLNBsZK/M41l7fu07oTa1XS9uo3fqta3jqvblyxC78rmBR
ePfldEKSsMBiNTmPav5RmRGaD3qv9j/NiKpcP10XL8m5MbHdKDt5WIXNcp6ZAoPF0rYqb3TkFee+
ZkXYvlSac79OWFLRIB0P0yatu0L5cX0pFz5PWIrgBAaQyVpmLgc0zPYqDMFd7txo9bhFqtAzq9pF
qW8Fw/fmsQRxzsGA9IXe6fnhsKu5pi/mG8fU9t0sHTdG4knpbbg25PX29/tjR3ABUZqq/TzbxjEK
GHvSjqW8V6uVhGFtLctvePUAD0U6K03h4EOLj2nWeVC0ujYDVrmx4tAuA9uXjfqzmuWXvLI0+7JW
NPTLjsg6yI/Oj/ZDLrvRO/WQfu9+DMhHunbmdmtR7do3FN56VCRGuaYPfsybbVgPLjILiHg8XT+D
a0YEb6FVShBDFm4cdcnZ2lG0i7NfTaxur1v5fzilP19QcBGSDAwHsQ/j2OTbXj9J5cb5Zv8k8zE/
S7LXRTuzXLnB10+HKgvev2hAcJMKGMeq2GvOXYryCgMHkA1eX9maGcFRzFOph2nAJhlBuYGFEhTw
l3z0VGeNX/ci3Dw7gxe9LpkxrFib2Ci4LaPAxR8tg+F7OEtkaRMWm/9sWYKfaGVJLhKbr9fqP3xT
vy2r72T/m6HWvOuGLhNlUEw28R6ctMwNXUxmZ3pu5U0zGseR+b2432TvR3jK3Oin03um+yHdr03S
La7nrMGxGFzm95kHodEtjnvpEzDymt7w0dGQe4ECmLt7fU1v3CksLH1CXmBoF4XD7oAVRx0LC3JY
+VTs0mY3FRDzWYmx9vSumBJjHCkzez1kyOiYmfEmr7axWm+06Pd/tB4R52AjxhNVYFiOslq4CVq3
ZlNuMmvthK+tRXgO1Rhck9azFssaNjqNBzn6VvRrAzJvHziALrR0l0FDsZxlOnMG7blsHJUP2XHh
7Ycpgmxe9wy0lUu3rlx0fKHK+Z98wz9WBT9bzJNcwHRsHIsFmvSxNb6Ya1R8b8XdnLs/NoRztwxA
zRYqE0eQau8MFI63+QfrGHr1h3Rne43X/46/GXttk+3U73LrOl+L78XNf7RMEeWq+8ArlGoyjpPS
kZ86HqlpWjxdN/L2Df7vdYqSa4VS+Unus85B+jSFqId//bs/3+Dq2uSgQJ4X8n6RKhsBC7+Ngqp7
aOI59RgW/CWN8tqc4cW8yeIcFtwhXHDAEC+gKDaAQSVtlP4hkXJ59OzRl55tu+6/JNPcfdXVvIpR
i+7qz3GaUQ7tQj0icfCz3ku6YPwUDQrQ8ilVh2fFLI1xAwQjSN2SadbPWhkhizRSrJ7cDIKt3M2k
ppWYtq/alRhWjP2XVYD0VS2uE8APkczD6bSyDVCTegjRN/zY51XvxnWVUcm0wk2O7PdC5blyl8S4
+cUmxCG8F4tqjvi0a2mXFZWjtQ/48v6XMsTDBgRs5OYDxJMGykxfE7l/GjXjcP1cvLHWhWZ6UU9A
xgZyzvMwcGqc2tF7eXhwpjbf5sEwwEQYg27uaCrAYRaCcV7jgnjLJp+WYwg9IymdEF9MKaDKYTaG
B9+GejT0+18Stwr5po+tNt/7Xdr/5cvPx1328r8NCl44NmDjrTRreKCBEm6HVProZObgqhPzWE3j
/2U+gjUWBdEpAh5QwhhCnKHYpRkH8sgn9UN1k0x1/N70h09Favk/m7pfIy4Ro7XFHCRHQLSxB4xC
8MK8MKqZBvnwYFhQA2lT13oBTHCbrEh8TyoqeyUIvYh7maMDSwdUFVgbnRsRbxYYRlOGkq09pNbv
SAveG5B4JqV+k8gEb77qjYZ9pw7ZfVyV73Tkgq4f2IuLAoyOzhc0IoBUIIBeXtxXeYtT24YUM2r3
oE3x86g3wWGSg3Yz5O0np9RQAi1Dy43LNRqmi1kHVn1md9mGV3YH3xzSadRYdax8Hid9Fxra3SCp
DKWW7ly0bgMet278Qzwo4GBHjWmcfMVJiI8E8l7wPgBkQRsJElURKFOntixFs2U+GIlse4Vm5O7Q
TGu9sTetcGioWerEry9f4tVKFXa3XubUHhD7qfZ5pqEtkzDEcX0fL9j9FnZdmouMg0K+bSCVef5B
LbvQuqKTokcYabsnNbPteOMPvnxC5i4v3CrLzW953DDdkEYFAnxp2qLmV1p5+TGAJvMRFchxH0/t
IWiKZDcHcnU7x1L8z1vwV6TrL5TkTfG7/d/Lv/ajgOs5CsL2//zvs3/6/46aHS94hZq9/pX/CP/X
A1nGJRk7/+Y/ZOwS4h7/QqRr4YNaVN9efPk/bOzkAvq/llYCeZCMtN8L7PbfdOyS9S8osmA6ZGbJ
oq6HxtR/87FLqvWvRfScYSbSDP5Ose/lSwe/iuXXBEXeCP/8msjxZQLoT2q0wH3Jh8DFvpxn8BpC
ANnGI3TKIA7vh6jzdxURyl07xKBke65nUg/9fTe2w1ZREIaFbWu+7fIi36pyknpDbVdubJSjR7oD
540eyjvJ1CO3m9PstjLlyh3DqPsYZabkxfn8qR67p2qKvg3x2H1EiETfywZ5nyQxr/BqM/69zNfL
Enp3LAs/wIPNJKW5KHSJA5UDSmMFd2G8T8vZPkCBKD+X1GxgyZL2Lz9UJuEImih80M1oItct1kbb
BKZlfgK/QEeABVdEogtn9vkFNiPTibVSke/nsN99saspf2B8Pi5u+kTa5nY97pTRl0Mkc9Tgi+LH
Ybnpbb/9LM9K8RgPeQHcy5z0wW0LZ77JEnDULpyj+ZcOmeYfsPRkp1hLuttBayy0OmUjPozaAIAj
nOMD0wf6u7quisJNC6RA3LaLx8atmhQSYjV1UFZqpdjCCa9VR4TK2cu68cLM2UF3vPCvCeFLXYXd
pFT1eJ8ZjvY+DdpqRjPMkTq30JvqtxKFcK70aTrscH3gjsbB129Hg3l+tXJcBWASILQpi78ipqn1
K0+EkAouv477xHWE2hG9Awjuz3clTqLYSQdFvY+hb/mWp2GaMh6WoDNTTfpXJo+MaZvUWnCKg3K8
TXuY6za6SgeWBBhpdonMGOc7JP4KduX8VVl+l4WaG6eEUUWiXDGLaqLGMZO6Ge7rKH5ul+5Xb68D
ZJcK2Nltx58wGsf6/1H6xFO9fqV73wgYda/me5n8Y1PXA8EQik2ubIQfkqpqbwkr5l9KqErbcJaB
m2apVO+yss0+ZmkRRBsTdRqTb9HH7ixPfu9BhAcVc6ZJe62deyLUvGKGxLHiowkdqKcpUwtLc24/
Zkhj5RsYFr9NRgEHxhhO4CYbJdI/6KOdPVtZ/RwZNG+2YQR7PYOai6xdXnsDAt6JC74+Vr3GGjCc
mNVPDl7i8QynawHUG+cXt4HrZQaOuJ8m0vk3qudBLeJwlO95f9svajLpiyR2btT8WE3aSEXU7Hw6
aHoTl+bGmjvrgxlWGcwbKHU53vAx32h1nP5c8WjLwTzfOqjvOR0M/ZOfMhh2/rOapmmToXSm+7yE
nVnyZ/U+mczM81WtO2SDPG8kaRgOc9EPn+a5QFMuNqybKU2yLyu/ZHFcwi9ZpkTgbwKSDM5KCDEV
tEnjvJRkJI0K2ph+agTQAGhsUtzo6FsT6e3ioIhR+Cjk6Zl0rlbdouEDJqNRlNvE5C653TSa3vVf
dh7q03njaBP+QSkF0hPAtOBxWy1tEUHz+0cryb+VKp/JNsJkA4050eaorqSGwoTeizk4OxcK5Bcq
dJE9Q+rsOkB6vH/M1OoLr4C8r+v7MK6hQs/7xIsrJ/JC8Exyp5c3mvylcr5T7aIfp80wxdQNYoWS
vQb+Ef3IQnpDSZUql7OMKInxvzQaiMENpvzYjFr1VR/TcJfFdX5z/UtfvK/UEQhc4J0gzSE2FbFv
kqQaSVcFyuMkw6nZN6m0baoMTjKfyHvqaTbLmfZcWn7iNlBtPcfZkK8lWss5e30O+Q1LiASCyzYY
NxYzu9khGmrybnrsRmfcW01e7gZdbraWyt0ILfvYO9a93ZjxjcUQH9MivX9v2ckx4891C98B3yBr
/bzxdX+N60lIApezQQLyoqTMdsBgJWSddNuNTk399NHJlWGTtL69ieyRmQS9idwhjJbiAX3/MmyN
9wly9BtYRY13DXHUWh4huvyXX8JZsAkk4R8V52z1IB/HTNbSRyVT0r0RwN/HLKLi2d6xN2hzZkYZ
3xmZTl8QEZu1PRK9lmhdSAspaXWaGsvpI8MZtauVjbwdZQ3t9iyvnvwK4uEoZxYLvhS4Z6UBniYt
39kIMq8d2AvfAI0oBxUCLmJmiHYEpzUmij7moxQ+WmXNaBTBuleOeXvjd1rxmMd54QUhyPpc8vNN
3n0tjPZrQ1dxrM32aWhm6yFmovTenMd5N4TpWpHi8j4tLKfLaaY5geDOy3l6lVR2ErUt34qjRy3o
Qm/0rfpx0OYbYzSDOyUeeHtquTvGcev8X87OrDduJVjSv4gAWdxf2ataLXVLXo7tF8LHC8nivi+/
fj56Bhg3W1fEuYAA25CBIllbZmRkxCMkQpgFuFSvnJ7zkrzZTjwCXXJgJTbJBQkBv//rEZwok6Ge
98jzGz5lfVN9NYIx35H2+w91o2le3vrhs1PaxfX9w+StqYEYAyg0y3aRC90OjGqAGaSTz8ClWe/1
luURpnG0wckn3IPdJCtrQSwvMDG/KarehCFI9cLFuR1wTGTaGJWUL6abQM7wZf9QWr7pBWVqPURN
OXpFXYld2iaBN/cobqrJiQ69mk1eq5TKaVB7jGhkux+rMtuZXZ9tDJDZrSpzY9sX/vitDlNraw7N
Z6sqtH1g6cGKENeb34woFmhrdv81l4FcRItyFbXRi2jbaKfE+rSNEvlF4s3raalhbN6fovmL3K0N
C8FwcLT5ml18MWdQ/VaZEvlShvZHOlC6Q5E6IW1x4b+5dM+5q69RFO9vV9Q9VRU9dPI3l0bbRWJq
xtGUhCry5NKsQDd88UWd4aOe3g6I3qhHRHaD9m/+6jrPrpk/R33UnPOmPVQgjzvh1Qpf/v2vcP/R
6SElVVFhyM3dpPPv/9ohWWB3oZJzhmj14GyM3P4sRPcyNaG2nfx8zapngQBxh/AFHKoR9KeSRRFj
3A6HvH3ctGMTvWTKZCabCm0gNKbMQKheNUzVTyPTroDX+0mZiaKJoIE2AnisN2odTocuUij4CPPY
BaP5ibpu8p3Pba4JCP15itulMevj04w5qxqiv7wIusgH0jLqJwkJPdUv3aBNn5quDx9CN2nLTQY0
n3pGkie611JUlKR7UbzLbfbaVrOk/qE3u/ZZc5Pkh0P9BcROw4sorq3W2Io6058yOInnwFLGlywx
xZf3Z/SPKvfi6elIcJhM4BbKPosptR0/JwXJgpckGyfPL51yl1DVOGbuJDZRq+lbMgyxSdtIbIM4
Pvhjrz+O9Th+sXzNPY69MBB2iY9VOVBEbGW4VbWGZgqqO1Zo255w4v4k5ottUJpNXWvTJuI8dQff
3xqV5Xp5ZxobMvJfQNTKyaxeHVyJPyBeXGwNIx62ZYL7aZY1T2MVU+eNh+LYl6mzLzMr2YyNKx4E
3ooHpyUxWvk2d3ue5gbchJBpot9YNedI86/VjompGtjDpFzHImg9kdbFNjOnaIXR8+daWc4AeRbV
MBrdCdwXCbkb1FquDWnwUtvluDXMwn4QWY7PHHfRtqL9ySvistnVijZ9QI9KR2Q0ai/0wX4M/Wx6
oqUxPyVuAjvbKL4LO/3UxphHc89+tMbhq9+n4W4K0p1al/2hFI1/8AWYk9ExJZjolSuX6F34DfUQ
lTJSeGxQbX1Zp3TUdqxYUcpVr3E2nCqRXN0p/H+o6/9ov/JGuMA5NCP8iBFQi1sejr5SAH6pVnqN
IjaW39lEtcFA0q5nF6Nu6HUI7T0CZsXWSdUnszLTlftHu78ReAJeEAMoKByEuLerQ20gYQ6jmV4x
p/gYFQdq+Io/eva/0sCTsLF3tR0/atPOpZm5GoezXrqHfmifivB3IKLNIN0VAGXB/ZyPS56IuiRi
ZrMpzTIdm0psUakrpdcpaPSjTlna08ZI7CdpwGLBKveRrl31Y1eWKYdOnR2yxpo2qo9LoOo0404f
4m7b55P8qVD0Oo2pgiFSYKLYCV+KgCt2/vNamS8Tshe6bOA/L09OKA9GqcVGeu2gdO7GHjfryIVu
9v42vsuS+CwgzMBxDIPMwxz2/bWNExV1GFxp06sTdvUhbvtgk2h6vfXH1lkZ6v5+xJ9vDq9pi9D5
62JNhF1kqXnvyusUpcFWjNC3Ax9N+cgWchPr6tqMv/Fq/388ON2LC1IYUladFcVXmTgPkdNxBujN
Yx27x9DQdoUePmVOcUr0YgNpxouUY9llh14fPacrT8Gwf/9Dz293e5CB78+3CCg/PmzLtvAgbRqk
LKvkWsQYQRcmYJchsaHMu/AorJgYMXIajzDf3EhlWM3z3hqewjpVzhlEJB2+nWezwmm4NAd5jQxj
Olh2VX3wx9J+svX+FKLkh3yg0J96Q2lhiWgtrNOxf04zJThnXQ1HTsFc+jTGlXYMVKCJzEdJXinG
4MltZHRuNP/j+5/rPt1AiAkNCwRO6NmjlHH7vHlh+boOtnetJ1ppmUHo4Z00txkycZsgyaZ9bSuX
3MnX2p3fODzBLkBuZhUhwAN9PsP/2hF2kvWsD4QrwBXHfY8WW+cY06euEz9VJ5j+aTSMs/VK1TfS
jXzcGMx0JZy+X7g8wbxScEWmxreMOkQ50ILRTeHVrevXrKjElT5MFIeyLFv5ynd4NyI1XKxkdbzt
3NWx2JOjlH1ZtDlDDflR2shHKE6sP7VKXj/aaf1coNzxHHbttkBgEqXEbVBB+qOO8NyOKAz+5znX
VAQTyCQ0cq8/bKa/vrzobWtq9TG66ti00jAf18+OFZsvwpm+RFV9rKws/aCmiVzpbZlndLE1NbyL
Z4I8IR5U+dsZR1ehLG1Ry6vmm+ZBsei8cEXnbt9/u/vjj9mc4QVgMfhEfzKav94O+qk/xXoWXmU1
dA+uDPoN8GOxmyzjQ62NK54Mb6whTnaDGj8wLAjT/Pu/RjNKK+5p1ZFXpXQ/JlkV78cJWBUgoX94
/73ur3rSZIfSOsxG9HOWpYlKlP1Qo5R17XrtZ97QV635ovqMcvCPZGzUnzCe1rw73no5BkX2U0P6
CE2P25fLyygVvUR9RZO6crb0+nOAOO8xsdRf77/bG3MG0E+dFdkLEphl11OYD91Uczdfykh0+yJp
rKMV0aEh+uJxhEa1sgHeyJZmzJy1QYgykxUW21ErEh+sSWiXKczsJ1No1d4Jo+mZoheAhxnRrym7
Yxjb05ninXMqKWF9cdtiW0Wl/VCFvjhWgTlRYqns4EfbNMOhLYbfejjErxBK6k06xdEKYeeN+eeo
mhcZIYTLrNxOhghRxrXosrtUlW1si66QL0punBubYDOrlJpeDGQt35+XNz8UDAhq52CW4KeLLTv6
UZE1bSkuZpwdoLCcmvpj3P7WFfGLgOrYhEhFj75npClOyG7jyQCZx/xk+Ic6S73Y7D45k+Jyxlgb
w9eOsm9XzpT7r8JhAiIyE4tsetsXXyX10WlCoCu4ily9tq37Wveq/lwK52yoVfraZ2W4El7dn2Jz
nsp2mJMLEN3F2imKGr/a0g+uAGnSy93MQYFdaw/vf/l76BoVhb+GWcIOGRF/n1t2cLXKvaiabewm
p8505YYi5hcrmb5MTnNIA+VcGcO/2IisVXFWH2DxZc0xCvSoc4Mrq2Ov9PCGzMhVPZLCfVuIfefG
T0rifkn9k0+zZ+pOa+YZ94cCYQmrHTUJzi4wmNsF3/tlbHR6zulT6mhpIU2Zju1vLcAoPK3/ef9z
/wEbb++mGej54yJA0eaurpc0uowioQZXvZSvqkYQlhRono9ZKuj90PO9McrqN5lL8DiD0V81tXQe
G8PKjkbNURxjTogGoeGe6zFQf8umsLBUShRLeoVT/ipqH4y9ncrP4At9jb5hcFDsGKVDwxjSR8UN
w3jrox25Rf1Q7qJAIGQ3JOOTdEJ3L8wxfhZOUuz9LrX+1ZUy2TTF6H9B68w/O0zSylHz1tyzo7CQ
oL6IsPkyXPH1snXjIoquLayok5VOv+CzlSdfKHu9E+3JtDsA+CkC2bKDfEc9W/tU6MUKQnwfm1Jk
Ja0mxcYJB5vT2wXQqAaAb6WFV5NliLJ5/NudyujQVX18Jsspt1rT/kyTRv39/mJ4Y1wCCChB9ux0
ydV3O65APzPI6i64BjjIepJA/yVv8Y3wR3FVCeIeBjTCj5ls7BXN5zfQVup4wI3kbYQUlHZvR86V
ti1LagpXVVC7g9z4u/FTuU11kRSbMqBJqEh6/+QWymd1aNyXUYziACkbnkQThjuzjqAHFcZFOvbL
+9/kjQgWXJHzFSgU5Vs0qm4fLVJQZgYjci/SFd8LsJBN8Y+AHQCbHtfpeIg/WE18bi2yzV6kp9aO
f9WovD6NcbDWPvzGCTwjLkCdGJnBFZ/n76+YK6efvbKwusUvMR6+uzl1XNWe4pVVcB/8UDjkaiH4
AfvWlrWgPIkAfbG4uqR5e+mScDjX0q0OfVdZ0cqV8sYlhqUl2SoQLgfdkosrskmPLNH7lxS4bRe7
ndwHZZB5pW1121LPu01SiDWpxDewIzY4X282n8N2YjmjWSkiq6I5jKZ9NAM9ozLMTZ0j6Jcb0VcI
wbaXdlZ4SNqR41dmwt/SWfuiT054RLCoRDa1st1N3RTKSVNt/KEKR/1dt8bnlZU3n/OLoxnmHtgM
OxF5PnVx4U69UnaTmjqXoLfSYy5KC7ryJDdNJdp/OEC+Z5penIdmVE88lfPglDhLyzb8sfIc8zi3
zzEbYxgUQ4gdKQXM99Vfy86N6SxqSr+4tlNW/GMhCPNAAikJxap+O1Lg3Voka0dh+Z8UY+x3HXH8
thuHTaEM2TYtxp0YpHnuFRRomymJ9kOBc1s2DspjkoRrOl/z09w8LegD0SK0VaSdHXRLb59WM0HN
cw6Tq1oO7UYdKpD/Rn5yp8ndDJP7n5cww6G4zzlNMEZgvfg4MakCtFg9IIVuJSzGKd0PilNunSpL
9laY1Vsu3WTlvLw7COZBYVdzCNCTYC8jhIolbCMbGVx7kJgN2HSCSUk6rlxDf2rzi08578oZKECO
H5uY209J3oown1q4l7iWB2ASYO3MQzbBa9sHN0K5INC3aXDo219J95grD0OsXrruk8hz6izFozLE
2wCJoCHqD3kp92bxCY9Zz4g6/jRWHvaON0Xowp4m6uXwsqAoLQCdKsPurExz5dJQONjZaYdOeSUP
cx70ERpdfEyiVtmOlftqj7V56lKkmbPEp3alDmoG1K/axwhe+8PK7rk747ArYrqYLfJlhMYXz0VG
HvfDOAbXlmr6Pqj86BiQJD3QaoCksxUfjYJqMClD8OyoUh4wd+m3Rh+2hwYaVeA1jtOi8MtHa8bo
V0A18gU22HR4/zHvdo3B/TbrUgDUzoDNvOL+2uNGUFSNFmridaQ0v0+zfwPUU/Upg93dp9v3x7q/
UudmcIZhsojmAYgWg8VTTLRIHlcojnWpcuNiRwM2o7IjbAwK+xRatXic410jd+Qjghkq7c7qv3ob
IZRNvXH//gPdZ3voaXLR4SilCRizSwqAM7UuIYhwr61Ru4ehrSckDNQAkBLy0GuLOsdT1blf8X0X
h56OqZ2dl0LZ0o3JHJZDekAR1kd0tqw/OlCCfhSlAhpMT1dV7vQ28L3RdX5DWkbx/f0nv5s2HhwI
kRoMUbx2l6YaMTZnmuob1ynsd9MQ2RtF5C8U6LguKAD998FgblKQIwiZB7ydNvhYtF1VpnFN43g8
W2aWbfyMamODscYR/QexMt7dKcfLAb4Y2JqxS1krt+M1GQsw7VteDqM6rxBogdmdunbKvTkKqxDP
c1YitL3bUdLUKkqnsowrKmvDpitKCDiuXq4ACn9QqpuzlBMABJBrVMWUEWTpdhjo0hL1xsG+ppro
zqrStJ/yOOi3bd2br46eqbNeFRmGtCcU9YHZd5psJ3Nri9wJsWGvzO+GDxNoU4da/JoToQTeFI7+
b7sZ7S/OWPsf+rZCBi7IVKvx5qh1k4RgOKRyap953VA5O2HnwbMdp/EnSN8QfaKhrisP1bp6n/kZ
nSTqmMf447pm+iCxBPYChX9vYHIW392wOxYqMO7G9St6fqdAhIVXWmh3b2SXiC0FEp8LEApmjAWc
nWtKsyviQdv7RgL3vQiiIfA6O6HtiWsrWNnDdzuBm4puQBiBpOV4si5iY7KWKWwLV70aURbtanjA
CPDVBk+VxFudQsPK4vzTUn0zofDqcS6b6ZcEywjX3k5ok5px1yTY3mqdenLsr1qnf2ta5xyFCTTl
ygvkqXS+5eH42iexp8HzLmVy1NGk8d0NgOlO6M1R4HWk2L/q9ndi/KIoTK1YUBeOvKJM9g1V5chX
tol40alRoGfwWFBIygDtUuWT040NMv/aC0KQ+1zLdmqibJt+pT5+lwzMbzlLukBVBzhc9me0BO+9
2hd4U44dmb6o6vMQlMnPaOo+vn+6vDkSrRL/tzBCaff2e/aBHnZOaEyXTtrjPxS5H1nU2cPUNMnu
/ZHus01eCkB5NruiReKuhQpGoOZbbjldcnN4jWrjR50kL44FETDv6mPU5bpnjM3vqMJB0ay9RCbX
nks5Dvtt4QDgq+XKYrrn2sxPxKVIHIk+EynR7cvHQkTqqOKXGtZ2s4lbYTzkogs9uzH8wIMuV+wq
MViHNNGcs+xSajXWqU7pWtAHJdvaGmhJZxXOs60XYpv3SbVScL87JWeJSZolCa15Rs7l2wfMVZI/
O7e1izK58sF0SiLAuL6uTMz8mrd7ChYeG5mZoU5Ca+TtKF3vNjRhCJyOyfv2muj7mKszMR96YlGv
CX3na5u7Vz13xdFKomHjTyocORpUDlYU0q3aFK391IX+zz6cGVFRFDKVsRZ7nWKkK8voDwNl8bRU
DumA4kqEj+wswphYGoVmhEp7sS1uwc6V0cE2InOfon9YknnUyck1lfEpwqjDK4xaPZDBo1efIW7t
B3p1TVCQOqR6ZXFKwaXThgyNjarCHUSr2nETFkhtTFqbbjoK7B4GicGha23F9vQg45VyA9hMTRDp
NfL04OrT3s3S+kcsaoyhoYL4D6XpB9usGZtD5iYZddeedqDRjvbACOKBdd7vwkZW22EU0Yni4690
jNpDV+jNh2jsnT2uhC/OqLksxEKLvvWD6l6aIs/3FPSHnd+Zz9za51qX7qFVUG5/fzn86W5efGCa
UpB5+JN8EqHdLociriI11pvhYuWCm801m+AlwOa0D/wJ4n+pbnE1+Vxr0n+m+m5fIsPAclW1oms1
lc5FL8g629SODmU41IcJd5bHpg1p6aiD4bmAX/I4+rH9C6cTfQvgr3q4/dZHF/R1ZWHfZdD41czB
Pz8wf4A7bl+ks4bYHMOwx0yn13YhljFblm93qDJN/cXq+lE2ERKVzdg1+3iotDWmwrxvlh8SVj4a
sVjezXKut+OnJTWOGtvSi5DS/qwpNbxne3BOQ09ESgAyHjQZlZ9aM6i/1QpZSouSV635vRe0zppn
7Z/S+uJpaMyCcoVQ+ky8XRx2Y6CLri0a+0IXn3xQrRKeqzOZ9tkaxtfJadWOp2uQZ5OdDtQu6+8p
rag/tDYZXyk41B/1zre8lODwSVaq+1LGZf446pn9rNRpOvusxXs6xFLPKdSUxnVL7ptJdjtrCEht
3JGe1aIOqaqnRmU+iKixvo343nzIiqJwV9bwXVgyszVhoROdg6XdlX5zPQDyrJz2oqPeiNJRLS9w
buQBBrC2qcq+WkEG7tNgd64xA0PCMYZ3s7To6CHYFzhHOBcNccq9XWTTNxKI4ClyCxxW4krdykpr
96z+7mAMU4m6t9H9bEM7/w4Lr9pxooqNwMhp5UPcXSAACBTAqUvDA7rPVMZOl0aGzdalQFaRHsTc
eihEvya1Ml9DN0uLqsmcbFMrJk0xlpwmXcukKqLJvbiieepyoXxuRH+il1H79/2z6e2ByBQBEGFS
LAupMg3NpAsxPEVWPntCqzLf2H5YH4payJXU/D47nU1/QF+otv8ByedP+1dujq2MPjoicS5KN6Y/
s0zqL+Sg6lerwrvGlVN4Tsboi64g6jiU+Rwgpu6HQB1ND+GZ+puiKBJmbmEdx3RMuVoU+cXKle5I
c3rQeTqQIp1Apvvr/S90d5f/aRCmtC1cFj4H4O1Tj23i4CHaOBdsMFAdVLXasyKszmDgdv05dkb3
STGz8dNUxmuOQneQC0PPlO25s4rm4qXkXJebIYkePrpOO8md2r/ag61ue/TnqsYKvXj019Cnt17W
ZqvPIA/c/uWRVplBpMex4lzYnfF26hRr2xVZ8My0Yr1Id154dqgtNZ4VDmsI031qyeuCoaMIAMtG
5Sluv/RQSTeM89q5NNGofVAzhNv0EJ2JqXLyp7hrtX1U++5+dCokyQPHmbZmouWbTK8DDGxKwoag
7M69WVGqK0f1G91DtMlE1oTYy9SmZJBlyKeb6Ihs40Y9TyY2Y6YMOzxTubVCf8R9xCRn3U00ch6b
JrT/dCQEOxZBQ7vRmOy7uhovCgaeAWAONlJSaTpskDC671LF8ArMEyYPlmR0rNQoOoXTVGzMie5h
w/Ef/KwsHmTQNU8Sn7NNXvaG7gFwRJvUGcaN1ar6x/cXr3Y/ofTEz0whsn76UZZekvjJaVHSxrgQ
KrqJn1FHLyNWUU9ROmFKZTYi3jR82kdi+k9lk2gb2VjRFlGc7oFY8UPUCLkL6cOjj7WFJ+Cnff1k
+0a0UzWxRla4P4t4VjgKcB8B1rSlvJTWWa1SRwnVL8R9vvtOttMnerqDKXp9/6vcX2YUIVAOmm1n
CHmXyjvDFBXwfhr9ok1XglVIqr1tHxtRfBwtbSVkur8vGGAmjnJnQlZbHrB2PuShnpg4TvZh96zV
jblJu0HZ/uc34nJmkoDSoeAsiT7WIAyqCIp+KUdB/NW1GBmm4b+hge+B7cM8eH+4N14KLjulfY5y
GDhLyeFSS1v8lKhTTkpPndNufUpqft+uzNM9xRCQlvdCagyfRNghi3hzzKu+tcgPLmoQfDPbEAL9
6KPeX6uN9FSreIzGQe6nIal2SHgYLyKMP7z/pn/ijNubmJreTBMhgofXtLTWTYZm6rVy0i/NFMc7
PU3645RFzrUx/RfoFONXOvK4EswqTz5rhVVuLFD7waXzu5Wj/lSJ8J/IHPsnOhjax3Lsh73SqM5B
R/F97xZ+fQ20PPDCyege/KQHuOvqxzExvCao6NOuRbFxuvRRxrTmJBC2850Nj8ar6GDeVkEUnmSm
5Wux13zQLt4ZTRbqENzTZMvLJLkKx7Jy3da4RGmL+r5tD+ckJ8TS40RcAtsp/6kU9woixYlHpQBa
g2Z3X9//8HepBtEA/XuEWiTRdKcu4EwzRF2oSnX94tCc9NCaJmbatFc+5qnTbpGh+96YTbaHrXyx
ylFfCVXeOIlwE5vrbuTxEFcWkX2uCRn1dqFfktA8i64RiZdnGFEbFZTk99/zja1E5u1acLSof0Hm
vL30NDsacb7PnUvej9G/gZt9K7tQXVnFb20kppE4chY0YhHPJ+JfoZdiFaqiYJ1wQWGaBpukV2A4
cvvNWouUkGp5tpUuR6Yqsw9m6v8qY/p23n/RN24iQCH6KdCsItQ0F7lbLBXdafXUvWA3cBbG+CzG
NH2xQK03Y5mnZ1dyJaaYr74/7BvflyaGGe8hnp4FYm7ffGrqyABtdC95Gmv7wg20XVDgdPq/GAWL
Dc56Fisc4dtRUi3twqr13YtC4+k1idSzrg3Jy/uDvJET0R7G/p7b8+d6yeITmm3g1u1gOZci0a9U
CfFEpYHnpIdFcS4so3zVc2N8MuzuswwG9cUMU3Pv13a9T4ysf4jtoDm1ZrNywd1vVAGkOtvR4OaG
Z8y8l/5aWqU2UjOCl4Xx3fhN6ermUZa0D/pu3smNVBvEwqye9nDJEXRSfMNZuYvu1xW3q8vwOu3z
fP/F0q4cNdBijazCwDry1Gd9vq0bDDD1+KWsUe/Osi2g5Rq16T40p0eAwGqutyCSsLyZkjBSnbHU
7Is95V+SuINuhp5F3stXSrffdaXrVo6khTIYfTmg9HO/reAV57rAYvLjLtaCulKmC7FZexgrMzoU
7oRs1ehXT5oV7G2n0h4NGeVbehXSnYMlzLaHx7ChcL/mrXXPPZmJCUTqtKjMQq3LrEhVip4EleO5
LTJzp0ouKbzgZfotprLyWGdjcWkyR/upugHOwJBLxineusMA1YgGcv2zoSKxI/wp3ZWGGl4LXQdK
0rnX//PGFDSr83wEKhx8ywZfGaWVWgpiSs2IrKvlZk9J24YrW+APgHd7YQoCSQ7w+dKC/7yYG0jH
rdSoll2CPMXmNQyxcZFRM+zTsXkM4zTbms007rJWFXtXbz/UE95NheG7v1dOiDeWJdcljtIszDkc
1G83o6+gyycKRbv0oxY/BHLKHwrDJAECQpIo2iuF8c0PR/SBszY+JLU9XiO9fGhpH/xaB4Xz5BYI
2ZDzVaQ1I4bJD4FI05PbrmXV96cGoQUy+wA7UOHvpWQp+NaK1KzLJJTpV1Cjn5R3GsY3hjfq9jEc
5KdEq6dvOdJXK0viD3hyO1uMPSsMI+tBwXnJrFHaSZe9O1gXHB48MJFzU+qFF7soaimnafpRpT/L
bviRS8eDoPaQWe3JAZDwsok4j3YWfGwG+WQ3tdc5j9JCVABjoNpEX9Jd0828D0RYu4gtQKFFgwvc
5HY+wzCHGxiExnPoGL+zLiqe0yQotmhphg/vL537nGjOHuiAn8Md+i4XcYgayFpJix69eQ3VwRIr
hH2f2PmuhnCxmxP3lXDgvnjFWChbwb0hynTpHLh9NVNtKIg0if5c9b4DzJ8aByWJ6OmNEuuHyFzz
ZJVZ6PVzvG/Gs9mEH+6ARIyPiRUqOJdLe191ZbTJpbUWNNyJjoH10CgOFsECmSlDi0tN4XTPR72x
LoH/DCmgqHCMH8MfofFFSbVthO5SF1uPXZadcUEfNujxeLH4tzGnFyuoH2vlaDlIHn1UaDpWisFz
1edKPEXOi9XBuA0TEnF9W7n9ZlaBGmDhDvWxyQ+dYq8t9jciP96EKBoPXkHIsFReJbmfMosfALbw
c1jNpgVThambbIuXwHfibY1Wx5fW0uoNwlTFoS6UlQ6b+zOJTAJfVAoGf3LFxcpCBEy4gbTExeoj
7Vwkygv+8ru2N560roTtF/Wf3l/Kf3KD5QZnVUF8huyHvsAiJAi0xqrCISAbNtOTYVa7jkJFiEdM
XNe7uH11YPsbCpR0NdpPY7ZpQ6iRVv6QlvnnQLU25fQ6OMVGNU+hf84N35NKcRmHXROHG6cRx0TH
tQh796x5ff/J37hI+Fb0TXGMCLiSSzuuUs3tLIx1cSGtHp5DxFVfg26QWPvU2oa7jAve7oKdaSjq
oa4Nc+dHItrWE0T095/EeOOABuBhG7BByX2XV9ogogxbudRATm6Cd2A8SrwTi1Rc46jfufGrJl/S
Vm4dJTyWqGOyiWAKjDvFLHdgRlc33ItQuXbF50E5wZw0q89SOVQmknXOj0h9NpHVK654n3y0gvJY
utmxt8XnKHuwVIX/ElxsWe96/9nvkFZDUtoLQogQTfzDF+ahFNMLPfUfkgynD7OhDjIp9uesdZ9m
5QBSl7Ue/j9awYsVRR78R9MFhIVm49vDysrnZLXo1EuFOJOhcOxPvmfF/yhDv2kJfSL7OsqPAH41
xUYcLvQIb6tzOPye9H8G/KaC7gKaNvThvgjomqeTOs/Uh9bRvyHRZ3l2lryg53CZcClrPuVoC6nm
8f0JfSN5QFyCzghSTI42fenqiG4MonJVO12M0JzOoSKQPCBbvKaFn+6jSSQHWef9U5v78qAqlQ8Z
PU5Hj37qdquYavJod0n7EAads9ascJ+iQWAgkuSkRQLMWirx912sjwWM4MvQRCeJq6AXWb151JzE
8SasSQB30+Ybgei4J4jrfjTZFO3NSaqe6+Yfcz8dvnRVvXKIvHVwUvSltxYWA4WLPxvkr7ymH4Rv
yISWNmIh7VQb4ivhbYjubu6+dGkYHSwLayC9EnDUQJpPdqivqSze3/5AHygazp3IfBprcft3iivN
XIffEejxUUMmAI4AHVuPUxiuBRr3bf8zzAKoR06D4vJdx4jpm7nbNf54qZ2xOyG3dZ6MMjmZtK09
BTECeWVPmwzu0+HXADJtAwsoZcF24fTILZxuM5lwKxZ61D65ndC+u0pgH0UVWC/qONlPeuSrK/fK
fVkdKIElDXeJY16g5Xe7KVstjpyydIdLq6Yn2iqGS9RQ+PZCVYAHRqaXcEJ71mAbL7U6ho9qROHc
d/G6b7o4OKGPGHnCCcfnukqHi5ZK57k37V1b2M0ZB6NyRwZ1CIIa/YKsjK9to/wbWAizrBy1b0Ve
qF0g2gQ/wIEwcvsaaTsZ8Nda/VlW6RaRBH8LjefSTXq7cQtjZbD7vUbURZ5MHQvKk70MbKDuOaFZ
lvrzoLTaplR0e1vW1a/3z5r7dUvXD+VizhSyHi602zeK5SgLqKjJxTfC7FI69esYuebTFBf/Ofef
B6JECq6FI4C6wOnofPc7Q9TJxQ6U7OiW3c8qcU+yj+Sm1+JzRuzvVXH6n2WcoKubFANpXoEqy+q7
fb8u92NXqml+iWw3+KxP5lcxhh+NIobM4jrtMQ5zf//+J72ft3lI+gD02e3lrpfOpyvbTqcmvyiB
Y52R/RHnxlwjR91HajMDkPyVbIN+UVvcvpfa612KygexDtSPnWxGB8w1lzvbSoU3CDF4StLFK9v4
PtCY1flRyKFdjWRwSXi0nSzwURsvLtlo9geuYOW1Loz2uZLOd7cyzpTHNTBofTznPhDHyn647w1g
Lv8efn68v475yJbKJOO6uExq5XXpi588KbCy+g77wh5nLNX8P5ydZ2/c2Jrnv0qj3/MOcxjMHWDJ
YlUpUrLk+IaQbZk5Z376/VH37o6LJRTXi0ajYaitQx6e8IR/eMY44qgCdy+674XZU0xDO6jOnyps
YUvtY0XsnrSHubrtcdGirP7NLOsHK4gwJZM+hNaWXuN7K4F8CzU3mvYQqJaf//bAlpjnpTlFFQVj
FKRb35Jd0yq2vOLeWwp0XMh/uAI5XFc7SxShSGuhWCKDkwRXaRQyOUn+aTKz3J7irn4wZnUrDnhn
TKSLYI9znJu83OpTyNWkN7OuZd7S3tdBv6pa80ETsl2kTG5c+U6NtnPXf0dc4j4unzLL/FD0gsPl
fY0RwIOqhId82NoT56czuIQFbcTSBMi3ruyOczF1ZSLlXlwMn1vdKKiIiPrVrGaoalTlZlp8Pgkg
8DidCYfowXCwnX7eUq6riHfuvLRX889Jmgb7ujLnT9EkA7mSI7jpqRoP90kj+1etan3I2dAf86gi
GjLQGax9MGa2pQfKh6zNo6u4NOaXzNLC58sH0jupygKg5+AlPkI8SV8dFkWkAQSrSyTOCV6OjSH7
t+2g6I2j6smX0Wof/LzZ1wUlPlsS9PxjNeOMXpBvbNwB5x+IxJabk4gWTBq1yNMJi00pGNIG9KJY
o06qCIOw7xqrOhSlRrdQKraU2s7rzYxH0LEclfSo140pEIdVXEDJ8qIeJ3k5q0pXa834LqvVfWuO
0m0xoCvQRWO825jxJZ45TULAoNAQBYO3dFDU1Z6UjVkRzN7ovCQSNTfKG/nQT5pw7TcwPLJ2EB7D
YIQyVLZIpEHp/RrxUzASkebNQON3Q2ZtyeW8s1rJDwFCAYpiEaw9VhIsF8WMpo2XtbJ+JJL1rzWt
ynd06YqvgG0tt0/Hr5fn4fwA5K4AE7MUnjUks1a3bzsFQ1VEY08hnJTUlBLDmSU0zy6Pch7DgFR6
I4kgd0r/cfn5b8dsXOH/Uad15SGW0YAfzJqDKZXi4xxa0Ua/9b0XWvhDsHMBCPCNT4cq27SaTNMv
vTEibvDBtFATqueNe/atJXG6fBbqL/AKDlfmba1gBR+UdCYX/fu4oQutT2l+RQB1m2ea7sg417hl
oX0vJ3W86dGRe7VaKO2KQYad1knudnQRXCHNGkfX5peRyGg/yH5kQ6FX0BJIUaku9cydhF798adf
gnVFWgJhGOwnNcPT6an11pgAUPj3uNxTp0ng7RV63hyGmvLt5aHeSfoIQpaAUuTbc+SvPkWTIekL
HKbyoHq8tGR5H6K6990hCTAqj0zLTjm5j4oo0Lw350WLsW02Ft4yxO+fScFZj9BLp2qHKra0ft12
7Iw619r2nnqnsB/MKHAjazI/9WYaHYekiI691jReHyq3RY9/4tYUrLe0gpLTcsIgcszeUtcorGiK
jKg0B+O+Q/P5ZjDl6iqqgv3oL1JvYuzmMbs6VNSZ3Dz5GnW6fyX00P9a8o0PpdDjRZRW4X4K5S+j
nw/HIpI69/JnOntEpobEj3I4y5hLedlQv+1NKwjgjExq9NBb1c9wGDRqLmZ9JWpJ4Sk1gFklyrsv
l8c8678tjmYUUolRCTj5z2rQIEeLHU55/JApavA0BBb8Ii1GQSal5WmOcK+RUw2PgiK3ztgI+S0S
6pmT6HOpwYMqtxKC9bX39jh4c/4rOiHbOp2DDigBkDwzehgE63sst18yRTtgTYuXV1X0G2tyebeT
Nbm8+2+DrbYgOXNEud6IHtQuMm98dLhBCqCVe3mKz18J4uLSyiW4JSg/u1mlPpCnsY8e5NbKns3U
JwfhKzs11j1HiYxyY6mvj3jKHBLARcIYdhrKPKsjXqaeE/k5bzUE2vdZU5MrLWlLJ5yErWvy3ZGW
/g0pKjfX+oQvVIH8rRujB8xDTM3O0e6y07FXZpvkMXYuT+PZQf/2XkS9oHqXK0VcvdeQwOTkiIc9
ILVOqcR7xVy6VxESgsM4zs7sdx/KBNQR5XCYOIarBdNRzOZ9mSV30zzBr6Aojh2SQ2BjI6uyD5Tg
FjWZ6yhINoL+dTS1POtCOFcXQB73+epZkdEz/Fi3ooewnGQIILn5YW7l3C17dCgKMRp2xaT5rlqO
W3nne9+ERpeGlCPZLH3A0w2UJ2ZdY3sXPUSZptpSFys3Uer7diCq+R+SjpaXpDO8vCdIFK7406GE
WZ+0OkKGK4yMDJvbUXcEaxg2vvv5Jl12KZA8lhlR4rqt6YeJ0MZ9ED+U8BppFiSEYTAJ95dX13ub
lKuB9IylhYDJ8vPfzl4dkUMoikP04Fv+fRr4vVdTk72uhGG8j9BRu/r/GW7h6aJ0gbHL6kIGuIPp
SckeheaBEKn+ixCzci3B/C6n8uheHuz8XmEGqY/TJ9NAy67rH8itymU8ihxzY6/ZYxy+VmKFVFcX
D4c0Mx9iuflxecTzRaggtcBEvlWYQb2ezmY/y2XYqQNtcFUHV5yO9R7pz87ulWrYOF3PKh0EaLj2
qBQ7OGAXmPXpWEmvQajKZQ3IhrKXG38/UgXdjWYDHXlor4WhFXZmaH7Xiic5kI9jdJeqD8X4Mcwe
mhrIoXotgWGWQ8qh6byPhFF2aiP/iOuCj91QuzdTBSWpYuOxz/JMHpv6HrXKRaYPgM+y7H9bcEMZ
6aNFeuklGOXYcaYMO3TKiV3D2NwllVZ+jlEMtPW21e8lse+vewmVl9iw2o2V/863IsmBlkvqoREK
rL6VVre1HieIc7dRK90srfnjKERwWgFvb7z08k6n962xOAgAU+BwIg1ZtZuQ8dcqKxNGLw8DFJtQ
DdyPYp1/vrz4zrfy6SirFyqCstRrP5goY5pg0xUZAwdTOiQKTS0/2HIVf+sYrl9qsWGDmo6pIKj0
0w8pCQjvmHUzeUEu7YXGfy5N2XeSBlJhiCfAdTV8FeLgtpNu8/hBH67j6kMUf5piT/Nv5fFHYHpa
/CAvjqyT01W9U+oPwOS8tHxpku9NfZ0NP4M2wJIYAZ69LP805+9zh5Q9HgP4s5um3flfB+TFJ+va
MtFzaRH//tKWD8F4G1nfB0vBpKCGcX3E3s+xpCdFexTmZ1F0yWyF4bG10AuLD1r1y+qvBukTsvk9
5UjMN2wj/CVYTqFldh8f9UVn6HsefB6ExM7jH/TTkxAKS/NiRK95/iuDIW/6KmHG9dRcS/Ln0ro3
OxBQ8i5HSlgAv22kV/iebEQ7Z7nN4qMJ0BQVY+rylA/W829q0RiSS4Ee7GhRdpb0CRl+7UdrjcFN
JYcB8vCZdAVdQr0tgPXZ6O4aW44ub2HyahWQVixoQSJ3FL6XXfbbds6S0YTM5Q9eW2NoGYnXcXmc
tPYFCwkKRWH6ShMw3c2p9kPCqVGUXuKJSl9udwBxKqz0lOs+mm/T5os5/pylV0s6piZ8DuG+U18E
kBXFXN4lxc3Y7uPC+KwW8qOWvRgj3WOUMRzKdhunwnkAA0SY3JRmB1fuGdVXE8PQGPRU8eQI/rUS
PgtUTp0Iks5ezbX8Bs1+W7EqbWPYs3au8tamAw+6mMMBcliF5FKVI3GmjZPXqXyk2Giqwzgjfplq
fntQYxB5aA/30pdI8Q9tlqdPSadod1GRlg9J0at3bdf5jg409o8vbMoy2AWiNwqm+QwYWSSJFqYY
03oNgrQF4tV7tc9Nh5qZXS1AtMtH2PlBickLZwllP8VaEKCnqwkD+kCcooLRkLzdT2WXQ4Adt8AQ
Z81RJptbmqN/kdBE8Hi1dQzoubJUytDaM+HK50Rur4Ay4xX61GcZa7APaaVpTiAJgRMHoDNn6Xvs
5z/0olTsvG6e0Bo91Enq9COce2XeNIA/P8oXZh23OnULEqd1NhjF/LidkDdIiqKlDYvvw21nAZry
cTR6osei/Lo88eeXIb+RuUfLFCgyuO7TiUd0o9KpjYueLEDNbq2w2fdBMbqKvhU8v7PBoOlzU2l0
Ehd+y+lIc6bOoRCAWzDQO9sFEbhGeL+d7YfzbRAeqKr5Pwat+3j5/c4ArssnJ+gARgTaGgTYMuO/
nVNKVgAuCtPZG6CHf8pAKd7Q+ypQ3JcmL6ei7YV5NeB6Q5KvCsKPohUQr4qm0mmVACwFid6hh5J6
pUOBt8W07jGNGpJvlx/zPGI1uVA5CiiGLMD+VaAQYe8RT42OeIfiFzC7Gukxrxr9vlTnyBkiLXaV
vttqf77z7amCAEEGeE06sxaXzNFyq/1B4ouQMs+jZFLuxhACLEC/scrOQIJ8BajmQCDh3pA/rZUc
J2ECp2VagFbkWN9JvYhdcD1/TMtkBnJpterr1CDSZZXpIy0AW8cv82tpaeNBRVjxaz0mz0rQ1/u+
VZQ/DtEgpugkczwe5Yo1h0zGWT5sxrL26G0EiCNpgl2OZbZxvr23DJdW39vlsnzn1TJMqxLkjFbV
XtTMwIrScLoxUfCzJbiDd60iqPt4rFxRbqM9kYi+i4wBLfC89hCLUFxQWfm+6MSv8M5mJ10sWKZk
HLcecrlrTu90JLBI3mkXMhMU5k73itl2gLD1rvDa7kuE4te17Nf1tZpqw5c8BzOTBxYsSH/Sbmfc
eB5a7FdcMSvDL504XA/ZH1tPKotmHuAGygq00EjvT5/HaGW0wrW69EJ4aR9VbSjvZzP+ko2R9UVo
YuOpnwDuC5F5K9Rh6pl6qL/ICIbiQDh8jqOapkklpn9+Vy2KPmASaZiQoK/vqq7F/aZraKmmQVg+
R00R7vs8md3LJ8L5jUhfhPsXQDrCDwA+T9+9A8TdVuDsPcPMwttujpD91SdzY/Uvy279xTGABSlA
CQDtkNW5k6bAHMSqqGDikxDBpqzcytTmnS6EoOzH+A87JMsHZSyK0USOCkjW05caNLOcx1IuPOzF
2huxE4kAB2OjkXh+rHHO0OUlcFm8WNZbTW7FgNRbL1HpCAKY5c1jMUrpDwsJxsuf6Ew3jteh7rT0
sLizF92z09eRpTk0UsFqPC4yVDw6yT/KRnzQ42Y6FIhC/Cxr+Ri17fStH6fIAefaOZ2sJEhFK8+x
kW8JlJ0BZpcHWqpTS3yDEpS5im/KFhBGjLGs14TDsVM124xLyYIu0PmwmbNEdIpsUJ5CNvKusERX
bAdrN4td9xnnxYX6qVoF3fpisK0Q4RoL+d1b/q5pJ1nbu/GAIi53o9Z/M7O4s9GWnJ771hKvmiKq
HTFt69kOlQj8XJop3y9P9hIenKxU2jmEJwuem6YpH/d0rstunJH7nERPbMCvqOEcoQVYWNedhFBI
lpnRVQ8c87mQyugqEoXZuTz8+bemP4peGp1ydWG+ratyZhrW1hynkpeOWfLsm9axjOfx6KfKHqgl
cPe+8Q/ofX3LyzhxtKLXdwZ+DvKMX940D/lGF/BskfM4C2WJPjteBGc2NoGkt3SXMsmje59ep3IQ
3k7w/16qzN9KOM9OomUoGo6w7lhf6N+czrzfhe2kWYVEeaGYHwTNaJxRpkl+eYLPwkNGMfFppSgD
VQIqyekocAvSEH170VvYwU4qt9lRKaQBwbFp9Nha9VOlab1bobi+ce2dkQToBFHVJYWlsAZPYF27
Bi1e9abVNh6WzvjKZUnzRcAmZDdmg3xTtdJ0NELtcy6CRIyLAPAkXn/e1IXm02RgKks3ucc7JPCf
UtTGj2WP329RV98ArT+Qpou2lFjt9WSNmSeEDfc4dZlfaroQTlBIlI8lull7ZcSXdSiFfQlEYpfm
mvCVvom8n3pry3XkLNbkdSnDwlblX7olq0A8LSKrx/Wa1mNVo4tKAWtnzBh+xpOEU4BidQhbGclh
4/MuR/vp/mXUpUcDlhBboDM7TWM2k6xXGw+FvwOwDqP5pFECFMoejLTbEVtXauLIxSGrnxHGsYfh
uoWNIeRfghhwePYYNM1uOWZLVaXY+egPKEbI5SKAdhRizKysl3KQ90kb79Livg0FLBD26DeHHe0P
KTuWvoKXJUo7UeuYauIGMtMfInx4B+k8SDRHaItd2A/72Ij3UPGORjq4EHF3yOFl4BPCGs3PPDyO
au42cbpbAsU0GZyUv+ZrbjIeWzUA8QleBYCx6Spavc9NDLH5bzCI2ECbezWNdr5wBXz7kBqSkwTf
RZ5mVA+dLB8afzpkFElQkKr7MOZihBt/+SOc579UOGiQGSSWS+F43ZPO9UakWVWLnt/NdinMGPDi
Moh4m3UrKFPgTczWYSQW28l6WkN+Qd8R28XqetKNX4JSFVeplhs7nx6Fg2F14ApQDnZNbSp3pG9b
qsJnohfAydH9otbFmuHoXzttWInpS0IqU2PS2uKYl1F1i0yrRNVwEG7UOZDuQzGN7BBMtzSYqivW
re82qSLd4H39FYyDlxv0yBc1mcqZk3jY+4qVPyjZvHXznp+RgAzo8VPnpe1AI/L09NJntVWaCbBU
SblgN2VjsJ9ko3q8/P3eG2VhLdCtIfCkd306ilWKWg8zsIPrZ+IlVqCEq4tItF0e5Z2rjmgGyBra
SEtNbB0U1l0e+qLSdA/4IBnXtMK+ypgh2HUmv44ihD5FzTB+7A8U5pykblCwMeIZ9+4giW6YX2kj
Rj3vHJCcAhGgp0z6BDl7FdUUWa3VgZCUD7WVK45SJINn5sh251Gg7aMqfMGkuHcHEH5OXhB6CWgv
O1HSPl2el/PZX3AczAcq1/DP19OiRcEYY/ySP8yW8WKpODSXgVhsXINng6hg4bG/QMeJJvNZlyS3
mgC3j1jwZlQ3byEkUv5rxmLjND4LppZR0DVk8cNQIgE4XUhxxDJVpEnwBLWY3TbtS7fTi/5olQAh
TDOM91006FfCZBoHAILCRoT+JoZwchlgWgYydNEnpzxD4fN0fEWecyXWBu1eGyLU2PFntaURu5qq
CIMdmacKRYtCoW1FlPDNCfm0KPs5Wb1iR0mKlyRaZY2cTA6KOJ/jvgdJFAg9/oq1IT+MVmwcTfrO
N0nTD/aE5bt7eSGcXaBkf5C6UPbCdGYRAj59+mLMsrZttcRLskraUX3KIVTFFIyG9lBL0ZUedeLW
njy7PlGc4a5exGT5ZHy50zFrdayZRno8GTZKToufycMQox1ijIX6w4iU6GosKE5L86zdYYiB0aWv
l1fNHJmHCX1H5/IMnEWfFCfZBDwMUSEN5FU1w0Jk3y+juYRsgRgwPk3K5wpF4V/CJKgbu/98Q9A5
gzMPFZq75CxDDUdN9RMBvEIl5Mne6Be8EjqKG6OcRZ/MGjBdaCjLV6Wvcjq9HQSHiVpB7PlGl+/j
ECPUBP2yPTrnwacqG6LPSeGH+5q+18bI56cbimA4h2K7BdFxySJPh07GwVc7vS29bmi13RiK3R0W
DDEGhPG+UMdkH0DstOs0LK4MTA561BqdOFf775c/6fmRsKgbceGCoKEKv4aL+cag0qxpMk/TAIqg
KdIeWs1wpHgaHst4mtBBp8NTqAMay34jb8zC+ZYiqUIjH/Tkm8rHKiYdZGwiZnHIPLg1oZ3DmDqo
ndbv2IEf4j4x3VyKt0zVzmtyoB84f0yRrIYay7oijR7qjMqXKd9zcakuAWrpEumV2a5N1OBrIIjZ
MRRnGP4Fmqc2ZZ/QLsYOPfZAT+7yMpGdop1Luo+K+E0rOzZ9UibKjZKK1p/ut4VajSYG9Go6ruDK
T9dIPOe9WY6jeK8K8kfa5D0VJxXxHr/fuH7OvgMADZIg8C2UaSF1L7vxt2q5kAGYKAsGmgXPyLKv
Br6TeYH2RF0nn/zM32omL7/v5CJYxqPzsBSgFvn91eKfazWv6fWL93BPWzs0xsjRgzTdeKuz42oZ
Bc1och3Kz1RfT98qT1IftbhBvBeEDCFszOGuZE5smzL7vFHhOg+eGEuFy/JGZuMgWR2N5RhJWTY3
4n2oy0/KgqzF3SVxVCBRr2o39oe+Ee/8Un6K9MaWAdpXdlIH1iHIaJfmo/nz8rZ+k6lezzAWAgsU
luYCoePpuyudWUejVYn3ZlBOu1wPfRctkPhaKpTOTkXfOsRimBxnX4x/lTrWmDak5PCbJc8Kqu1t
Zrk4ajWHOjBaG+/xfO/TqjjoZlodkZr8OeppeAQ/KRzERHv1k6TcVbU8cUwJyo02JNl9NBfhS6X7
05ca8fZjWsjaTRepulflreRwnuO/qvbVLReZ9Szl3aa9znJ2n84AXUzQOcQbUNgwkD+dAcMo4riT
S+iFUqfv9AHu+NBLj0ksO1YxaDvG1HfNUCPcp5iBU9VCtREwnDfLKStg1kTUBTRoKbeePoKvG7Ec
5JBB5Fy4VjThtlOCxq1qY7zJEOu7bsL0ZZj7+CYXERHEYbKEeBArmG0kWXSbpkyoEszSAWva/pfe
purOb2ocmlP493EZHGuCnEPMle1WRD/uII3ibWNm5XUVKa0jCsjuO/MEpXKeFP0u9yPVNotMuJUU
qcJwMeesNxBtivKHy6vvnSMWZRDq5IugD6rt6/OkGoUy7qoEis2kCHsVKXpfVxqUNiKp4riM2u42
E6x6VyfzMR3mp7ZKd6mC963YN9pVFtOEJQhs/Sf6n9aOoobXmYOycbqeH3o8JCQQ0ipiDC6C069j
BgCparMRAIur1XUzhWgmplCXYhOQSlTHo930irhx452ffFRqaTpR8rK4+NbSe3EpjOVCyPCqIJif
EA2r78Qw3mrxLWv7ZO0v7CMFUOYiCIIC2upeRcC54iVQUBBZ//KkDm4xDonbDnEFonTThOD89KOo
gEIXYRT1fTANy1v/dn+YOietlk6SFyclAt/0r6mJdGPzpRhUwa38GmsCJbqfGkm+ipVQc5IC4XhZ
GJudHKfjE7i3rdDu7Osuj4SaF7EFBxsNldNHyhtEQIwJKR30577wb+akWZn9yApwKoEqRh8nf0uJ
/ezbvg0JpB31HvKcNwHd32YBh+hRnwpf8qZIC5wW3dNdPBbDn5aAkUGiZ7movNIkoih++mKiiG51
QkPUU2sp2Jtzan7p0G4/ZkKhPF3ex2fBIZEZw9CJYgKhiq12SFwOMbrD6OiJddLdR8lNZ9U4AVqW
kDqoCymiQ4vdlZF7v4YlvDH4OUQGl6839UiqQbRb1qCIOcHQLNLbzBvQvzugvegfE82oKUhIEsxN
/K1Ed6jEZ9EMS7dvUgmbgqJ3M4ridjlovhME+rRxpJ+H7ctDgTtmXhZO4Zq0bia9wMUeZl6kqM0V
RW1xVxSFdUhwRrETmkZXvSh/CLXRScQY2aYoOfpyulVWPQeD8RhURxZ9G9IIEonTRaCAqcThZ0i9
vJLuJjEK7hDbVFyibJBMUlXsUkgdO6sTk92Y4+6dJvlGcHW+v4gqSB1IHqgmnPlkZHOQcLX0kMQ7
9UlVheCqjZHNEsKy3SHm5aZKtbWl33lrgFogpCHpiLjkqEvA99sGS9HrbJusSL2pzGt0WEvrWx0K
2NG1CaXLwRSBd1A5iKmYsUibym1GiyLB5U1xvstPH2IVV2TUiJK67lJPSCJhX+lC7KZFHHz841Fg
99PjoUELC3+ND8taSxKSLA49eQgB2YmSsBtyWEyXR3mjo55eFJRhaBnC20YFkJrr6YxGk6hW7ZSH
XmANOy5zO0s+pUq0g6y0H7UvlvwQa9et8kkdcseIVRsUrW2l3W4S8Bru7g1/QpA5wqhQtNvoRZ6T
eyW/1tTXLlBxjH+Sw4/+iK1EAvayGxyzAWpSpUci872ZDx9hQt2aQf+prL8VmKS5dfkdueM//14w
ALkDwTZwEaxpybB+uqCL5MDDVOXGzAQZs4hmM+JZMpb1RJqgCNESXFgC63gbkdmRCKUKvQTl+mOp
TYbjQ9E7TlaxDwUjcPHoqJ3BjC3HAEx3zFNZssFdNBtf9J3VudC+ADgDniWZW90ODaoeVofAiDf0
sUJzA7dBcamQXl4355sfchnrZjkB0Ktdn4JlZ/VBZOSBl8/18yDO1lPVGO2zwEGFDUpkkOKwgD/8
8aCE06BUiOsBb60D+rABRBWaaAvNYpNezThF3IAsx4DFH/dpIvQ7ItEtq9PzFyUlZiJJVfHTht1+
uj8adQzpCrc5sioABDU91j6J5tzuzHyUdiyj4CaqsvRw+UXffDhOFxOjAk4CaAJiDpmK01GtjD5a
NdW511reXPiOFGJwqKVIjmV2AcVgHvYdJO38eQSEKw7PqUA2p7r+cFX6x5JalZ7ct90Vyi22YT72
0Te1shx9mo7JdJQU7Gngf0HOyoq9MoR2rDxJ2Z0S3hsWZeBAax71WdpPIqD1JkXksbEjrlUryvZ+
mx0atDJ7qd216GUaTfKSgXx2pxTQrFkLkRO22AUN9XC8PCVLpvT7jFCSoEKH3ayxIG9ASJ7OiDGz
t8UhGj7kXA7HSsQYrcIN8igUokJvDhGF1ugNN+vUrSPyLWo7GRqxW8BIBO2LoQOlhNOhTSsLZy6l
9ANKmbLdokD71KXaQy23wRUGLrTQAubaNzPfVWK2t94N6jFugZJn+oReVp/J2PLq0XUBaMDJk8za
VxyZBu6tT3OG79bof7o8WWf9PrQlyPzNRXeQVXTm9TiOQRKqtS48knofUVEprwvgUl4Zpo0rlFp9
FLpml2piuRMGAphpFE3XVwXpITYj6zi2WBx3lNT1ScZvvJeUp8ns611bBMlDJsfyxnI/C/QWxA6M
fNxJOEFpfqw2WSFYVWf0tfLoSwGJgqw2e5gExRcg5t8Ev0OGDBUDR5T94i6YTc2udKtzkB/29xU+
VQ73FWWIcVQ32hXroxTYHp29JY1dKBxUik8/fFLMQmEVo/zoF0HoxrrQ7Log9DcqR++OAkcGfzNI
+HRpT0cZyzTMh3nx0piico//Htuuqtqry0viTYbl91VMkQ3gFdhu5S1zWN8LfSalUpsK2mMsWdVe
r9XJKZF6hRAtviANcD0kSuImZvqsLyIdU9O5eR+X7jSi+muZbe0W2ZgcrdySrlFb+Vxj42N34VMY
RiFayebHWBPHXa/kxTV1dp3TgQwIaZXKkQMpdHPVqG4tP9OOYVjmjjQLyZ7irOaoYmYg3dki+4ZR
tZNXqvpsJnrqqIlRubFophs319l2ZiKYBToKHK7EoW+L8bcYMiqH2WrxCXwk1nG1PYLvzuT0V5FL
mf9mdIq7cAfHzyu/ta/Rk79xhS1LZvUVFng9wJ2lHEmWePqxUVpu5bBu5UcAn0donGpt7HT1IJEu
XP7eZ2yxt9cEdYEiFUx0kN6nI2G7aGbsfvmxvDUP+iG5H/fllbSHam0HrmSL+8xRDuWn3jUetYNx
Le7yQ7ALbWF/+TnW9+f6MeTTxxj1rot6sZIfkQm2NbTgUu2bUh5qWQdVurHG1zuJWBlcyxJ7EZmg
JbJ6ZVVZqikhcmujlGt3hhl8anLL2si+3x8E7DRlPS7mtckFAVVV+2kGeDrCTrGI4sgFxRptvMpy
wZ+sE4RJgEDQ61+067h+TqdNG0K0XOcy9/QuwL4ZsjV60EWwUPP9HWoZ32gNZA8VmDlHSOatxXP+
jguW8F/VHMraa8oexeEJIiqjV2KiQ5+ciiXD2nKuXI0C2GtBGWDAu7TXKeEpp++YpVR+MpQnPCq4
WWfPwHyPKQn14+UV+KaL8dtc/mscauCIgFALY8+fjmPUaGOA7ctQZwR/lLZmdxiK8lHOtZ/irEnI
UurRZIcTalGQ6fzdNOj9nVZGpYubkn5ErLDZVVI42GIvRRyR7Q4NQQCdgxLuVTE9kPztszjaiRgs
O1ZgPEtGcheLibWzqnY/KZTaC0vQNrKaVUD0r7eiN0QfawFnrzUUJqjjfpvzVpUVPE4qJd+ab6XB
BrWR8olsNUCospRE88829Nu4Kl0iTnGiKlq0p7M5AYY0EDKnKNNI2sc0S6PrsiOta9UssNPK+NyU
W57Q7ywUUCmglCmq8bpr1EKicpkMVZR6raGGR3+aTa58+FFv6+Q/foz/GbwWD/9aEc1//xd//lGU
Ew3csF398b+98jV/auvX1/bupfyv5a/+3//1v0//yN/892/evbQvJ39wcwik02P3Wk8fXhuchd7G
5BmW//P/9Yd/vb79luepfP3n3z+KLm+X34boWP73v3909fOffy/OHv/x+6//98/uXzL+2r5+zX+E
fz0VXRu+1vlfL/nPv/4Xzhr1jzb68dctf2zWv+z1pWn/+bdh/IPOEeEuMSQzD7Dp77+G1+UnivWP
pQ64nLALm/utUZgXdRv+829yu39Qr2Ar8/c4fN9cZZplbH6mWv8ANwChjG4+7bi//88zn3yW//lM
f+Vd9lBEedvwMCyw/9nOi7gYF+dCTYPJxRm1RgXFWMa0xRyEjqKFzXOiGAnWLpL+0ouqv0+VHngf
zuvubxP374f4fdA3hNzJqDRvKHVxbTM8J8kqFqRQ7aekGbGTJt2u6u4l7TY1vtfW7Rx/UOPc6evH
Rv5QtbGbLZ67VrqT4ucqf1KjZNcPXzttsAtDvMrq73R59ngV20l/RAEsNcarjMaD3j1CYNj3PsqH
auBE8a1sPVcSDfAmsQmGbQumgdqMztTlhz6U7FIkPCoPMia+LTXRy6+7QuAxyavXXd0/Ss3JhwxG
7BhP5l10X9mdndnzTtgXTu2VrvKYfqpTW3Jk29q4+U7PtfORV9nWMM6C6IPloWHUdTaQWc+vvwRS
7FZ59KsbtSu1+bXxssu3u/Rtl8v4t4iw0HSQPQpDApxx95W7b3c0Z+10rx38Y3GFxeP+6fKQZ2v4
dHrXfMSpKAZaCYwYEnem3uyo+2EjrXh3CAL3hXNBEWGdU0ldP0utTDF0NH7MJkGK9hBUCLgVn7L4
6+W3WcG6/v3NfhtrtVpSrTaqfim8Bvc5zZ+f5qH6WB/Hm+IAgeg+eA2uZU/lSrrJH8ND0NrK8xjb
w+fLT7GqzL89xeI8BpOJ6sgSn51+RjVtujqO08RpkPWVdiguhehO2v3klrodBnYk2fIWZvKdpXMy
5mq1ZlKti3iwMSbZU49nbd5iMhCMdJuKZN5vvOH5aASc1L00CrVEZ2trakpQQiYgiusYhaA6gZyO
j4EFUTmZQn2XF4pyJHFr9/lcZncqPps7IBjmC2ZQ3bGplArX7qbzSMVlD+5U8joluvpnq47jkVCE
9h+HJYK+yNSefgNJEyTOvwgdTS1cGtoiPQgr8m8UYQLQ5wvgoOmTbBwZp/EBmo6L1SFAYXhF/AOM
5XRQUcqsVJIzHR14rbEzM6j3xD3R8fLsL6fAb6cE2HXeibIqlYr/zd2ZLDeOZGv6VdJ6jzTMw7IB
kiKloEIhUhFSbmBSDHDM8/j0/UGZWVcE1aLF7U13W1kuqtJKTne4Hz9+zj/MN+OyGpCMFFRDux5B
R+PNAWLdbCmBm5lxrGRIYUM+Wjd0psD9x5VphVRdzUuvx+UWB0ZAwkevmtwL1DHuLaczbUp6HIjE
KVsV5Ng60gf1pu66fN2qE6IEyPNvAHrFN6UhR6sxUC024RDd103kX5D9WUQXqgj03UFmA10DwEZ5
9PSHTLnTZAGGI5tGMycga1N5ExVludMr+6cGh3ELgDW6cAcvFLzm0gXjyfOLCLYT/1nMPtfyqJEy
waDjkB6KtJU3YevED5YaxVuhaVWKN8M4rXR8EUiFsW8b3BDUwejZ0BZ1F8HpS+TmRUdq/k1Ak9mC
vAbBsClLedFOlUXel1O5EcgjIdozxje+1WkUJyt/I/v2j7infpKjxaQE2LY0TmleeN+cLwtYNlr8
NhxWzIwpUJ5+C2PyS6hfJZKAkaMIj06NIrtm0sk5wKpc3GdmpPabyYBPuC2KCUyFqMpnC/1jE6Pu
fiI4DqX/8vFpWTB/WZhXIh7cDwS6+M/yBasHfS11pdrh3a0hV0j9drqPQG9vM8CG95bRhKUr611B
FT0Yh++YABj2KrG0EbHgqoru7DRNFbdXLQnLvHKaHkJVC8LVhV+5iKjz7Yhyoz3rV1E2QIbgdO1Q
qWus3srMLUff/4QPYfqo9LHvIqCIxlM3KptYwx3QtgKqFzDsdnSh8VSxG8dD0LX1dPywvKkxUIYq
YgCCTXuhBrmojc7CSXQ6wUoDVuT9in706S+MR622WpoF20JplW0cjNZ6xNId8wIUUZpQYE9fFapL
+6m/zhVfQ68Pqjq+vOk6CmzFEzo0PoAQ/YXLaD7hb8Lh6+/iK8M3pDyObtVi1xWl1jTg4M1tRGmP
60+ka1rgKppfirjwld4ZasamEtx5AlIiXdR15MZow7RBjh5e4k+5ovvSaxW1fgoMl/LeeTVPZwXn
lrojPEpUVs40NpW6LIfSiP3tWEXfRyeM0N5gPqqGz32YZPqRMm753Gp17ppNXGENXlUegrK21w+Y
i1gom1443ot65bwBaHrAfZxRGHj1LMnQvUY0g4fmb/2miX4MiaZ/cVpjJweJ5EUYcFxFIsxvEtE4
m0yq1AeFQobbR1OzGfoQQXpfam9qs5vZGp3drKu+ya7jqU6vGvBx9yXX8Vrppmr38ck6/2b8apBA
PPZ4N8nLBmHC9WUjSupv286aPoUhCjBDW8rbxJfHC9tj3mmLb0YJBGnH2fIRUMCcHrxJ3404cMwh
NJxtXujt0a6iINqUoA0fx8JvIjSurPRKjZR4m49U1DZVFhmXVJ8XVgavH4lHMbX1uc08y7Se/obR
bOO4zlV/m9V9+S3v/fiLPtBIK8SgxasEmDle8gbmXl4DledHxnmCkqYX+nqyZfzR8YVvHiwck4N1
lOBB6CkWbMOVXZb5r6gUA6qGWoKdfNd02qe2q6Ln1IiMfGulNHGucsuAoKsgYHThnXJ2vbH5uG5n
jBw1xpl7dDqvBo0MVJKZlw83cJO2dLW1SkxbWa6btZEmGQ2LYFwZkppvYAEnK5KO9uq3txIPbqB6
kIHAKSwPgAnhf7JrDoAzWN0mLJLpyu8S8yZV40uIwDk9XWylWQOI4tYccRGkOZ1uJHcm4uSytBWJ
b6xarRMrSg01MpaDvRrQE0FyEROPJrcK7+NJvrOJZ0jgXEABOAmQ+HRkn44FVWWMpyo9AVGEUY+H
cYiyVuIiW0lpJq/TEq4ATtW5m1PpvpBbnd+D4GNnlvXsLoNTyWL/cpRrLCfDYKe3uXbdF7Xs+u0o
32U1faJwaJ8+nu0yfWRbnQw3R483R3ZoRCrbaPLuOLg23VzsUFrZTDYjOd6qM/x2lStJfCFOvBOS
SFghFQKXenWzOh001TrukBY1/Cawu3VTS98sQgH2YH1xYaR3pwfKc5aLcHgLqacjdUJVGztXmB5P
kxVEFheMXfhkTZ1/raW+fjDk6a+PV/R8cgRAGktYGwE/pNp9OmSsj3bvl0xOqEV/ZUUjD20ytHWh
V5cUKs4PCUPNBxFnAd4aS164pNHd15qI5ncU5akrmzlv/nBCb6M3tGxtV5hZpTbEwBw8+cezPF9Y
BB5nt90ZUG0w9ukshymJHLhXwU4TdraTbLBCidoNt5U155Fh4a/kYUovpWDzXz2NChwKZKrmJJ9D
elZxjOxEUUY72CmFUnyTGnoh2BtQkXZRABh+mWqWPASTlWtAoUQ1ecjiKdfJ6EglRcAseMID8VIp
4JVrtvhNMx+RLg3tGSSfFw9tYvWQTbHjbEsbycZer+GsVCSkpihR8B+RIqizylipdHx3Th2N17Hg
tWYGEs6ullyCSkj8L2mMMkQjlBwGet1el1E/PqZWVK3VLPdBQBclmA5jWId+VNwlut3urCyOd0k2
DpCto2aHlnt6pwy+tm9GLbmWtRBUSd+V18NI4za0G+tCWnG+AQiOcIHmlxYNAWOxzXs9zCvAGGAU
WrGq1NuJjLMxHrPyNuwucXvfGWtOXUhxeR7QUFxcBgM01yqt6FKGoSX2Zes80viQb5BJRyajSI71
dJFh+M59C2ILCDWuUSaZ07J+EqJ/MAVATLD+REVE0YKt2YgBM3F8stHrqLfI7SJi7jjxym4065Of
j/6FJT6/CvgJXANEBwhBpFSnZywP8UWZVOCcsY2htGI6z1JbBitznNS12ceX1I7PAxdiFiwuXXEg
06B7TofLMiihBRaZOzsb22tFCsv9NKjdp2QcmwtFi/M7du4dmDQByaQdVOdOhxqbsR17kYndYJvX
Qe5XyO6l1krXYe/XrCbZvO8fgBmZq1LvowsPpmXxhkR+LlIRv4Dk8JQzFgsLFUqTukkKd0UOLSMb
Q3tXBppY545Weez3aVuPqfRSd4mytvHd+Jzl0je0eS3H/d0oCpqFCM7rDXo1Sn+n62AnkZEO2CDs
MrQQzKQcVkoqTU9t0mv7Smhy50XjJSu0+WCexqt5TBQ+TICJVCnmb/PmxverqMcbxoIkqyXh2lci
sSeB7S/s3fPNhPKvQkcZpBa9wiUAH8W8VspKNGH6DHGJRC3VrVYh8w/HsLlQ6XxnM80rOHNHcCYn
QpxOyKm0Xu+tJNoleY1mrW8cE5nSG5Iw8lbhUeXpXZ58igoZGewMV++PP+H5IWWiZIoqD0Oqn68V
+TfLWSh5G/t2Ee0giSfrwS/zTekbpTvk2m7qrPrCyVkIDM3vG8Zjh8Kj0hlzGZeIMiXNJ9ShpUkT
q960hrUhV+G6l+pwm9aZf9sWXXQtxJhtuLJiT7EbsRVN07llW+GKKLdo/7Zh+CK31Qi9Kbe2Y2P4
K5Jc7BlCp9jlEnnDJEr7qpGj4Apu/7D3JwkLK6qxz0bXfAGOXz18vI7vBFwmRpyla/kqHLU4C0Gs
iLrN6mhHEzTCDgILDBsjI1f4WYAIcXUDwky+7oemXdkD/3IAMb36+De8u7jYRXCv8YREgW0Rl2qp
bxXAX/Fu8JVyPVDrXhXqoNluXitfAaZGn6USljJlulzfgqFpPoFdsB8VpRuv5M4WWzUvn9o+nda1
QMypNs0eNqVhbG1JA52oYzhskWhfZwqv0K40aEdKkp5BTuifNf5uamnZFSKElwz+zi9Q2ohg6OQ5
2pB3L0J7mRZhJHCCRm1XjzZNoWTrqRwFLiSBtkLAGmuSIhufP17N90IAgBmiGqxHGPPzv39zMnQl
kjrcN6JdabaGK+dDTvW311ZOZeQX3mzvHEJq8TNFl+KvBYDxdKgwqFslair2jpQrCBbJwU0bgJpV
tWG4QnXkEnTtnRiKGAaHj0sXYbwlWd3Jq1lfh72q1Iq50vQKCRSkBS9sx/P0XmcI7ihkTSgsL0OL
NOE/JAVTtPPBwWyplQgPqG/v1Qmv70bOnFtJ7fMV58a/kGi/O7+ZFseWMenwL9azCaKuiFQ72tWK
DRlekfKvmHVWF7iJ7301OlOvsrNzLFukdSPSp5Q6pGgXDY6yzgPZ349jJ20lS4q/mH59STH5/fEA
DfBsmV/4iwiDrkla9S3r2YXRGnxOvlEBdXm0ySBjovX68fZ/7+uRZND+JKWaPflO92QMCDRwLEaz
aiW9QTMgXkHenbZDPHmVMu7NcngMpOD36wcsJT0xTjnoDN6hp8M6tIEqPzOinShUGKmRVW4CJWnd
wB+lvRXKxpePp/nuosIKm4fDu2rZjGvKTHfSTuD4UShA1Kck++RHfLreobDZ5f0lIv47tz1AtRkH
PF+65Men89OyJLfDkrcPVU/J63Gb2A41aWMD4WQnyXq+drAqo+LqiG0vS+JCsvFOUCMfn7n5cwH4
TPUNbSET2SUz3hXMjcqMMdwOUfXXQBdw+/HCvj8SW2fWHSEpX5wOQR/biUuR7JQu8tdB6FTbKqRz
ThE1vnDc37t7Xz0BZnUPhHqX9wMYw0GpqULvhNyIl1ibyt04lhbo+AjPIrMtdsGQ2fs+n3yPZKh+
NLr6kqbLWfdsBvWAP0cIbi7dwlc+/bIFDIzMV8ZoJ0swBmUTHSHydKD8qTNthNVBZLNSZcveRxo6
E7kXmJpgG/jFFoX/7urj5UfdhPFOE2U4l3R50USAVQfc8fT36BLcYLWcpG0YlYriNpbIf6WNrny2
cktMV5QJR33bFLH+I6kSv7wydb//NJS98VQ3xUDV2VQOZjZU+2aooH8o7aB+iySruzb6TvsKEziW
3RHLsrvJpt7nyrEYhat2Qbez46euye5VtWqxmJhae0PfM/3ph1k/rOHRG09Ystc2YSRa8XBE7L2Y
7tVWSW6zBl4BOH3pPtX14k7SRBS5WZ82oxsb8pgg8UZiuip9MxZuGGDtioZ21qw6TCKjT7oIMGDo
Jdg0m4qubeL6eApctVFZkPMYkODcOKptBjWa5HuOeu7XNA25cdOh7V/sYkz2NiKC33R8WgSKPIJe
tNlrvtu2Fo16pM1SdYUDsPlJrpRiP5QqWnFaNKSPak00rKpgMK/oQfLbkDZrY3fURb3GK8N5Lse8
/ppOaB+uFCPFUySsG+nQ8LNRL46DVFlNYao8pXIWHNohD5H/b8zYcku5CQ+SkRfwEqzRHtypBY2Z
KJHxqbeLn/jbfg0syTLWQ5Ipj2UTZsNWHWnF3lJu719KYO/rWIYy71IqjpRVEFnadl5v6zMiuPXo
9ogl3tgUdzIvbcnBqNHqVr3WELD+BkU1frGE2jVrk5vmSc+tPsAuwRyfHKUxrWv64DpCdl1o3RbT
KJ6NOPSdXSVZyk6qKi3DpKNrbzGrrVFiSvssdfG0rPyrzMjxfp95AAgZ58B9JLP1985gVgc/7hXD
rQBBKOtB8ifbDdvM4qqTUBdcSaEzHVI9pJPa+rkNzwCyDnrGosseUq1A5gr0Z7PVRZ7f98BYdxP8
2RVKifIe2+DiHttYyt5+W9J+sLqu+1JkU0lnp3bixk2mVjnKPtFkWyVt9GmSK/kOMeNUd2N/gMlv
SlI8uKPZy+KqCOVg25qlNnp+Orb2SqnNfT6aw/esRPLJa3TL79ygL5tylatygjCikco/xOTH4Jem
SbZXKhK9j2pfdC9BHUcOQDz4fG5dycWTZoT5T0dPmoNmTO3zJIfKwGYetJWOuDu/JOijz1ETjIZX
j4bxYjR9JXv+UMoFDn621LMNBUDAwagOqCcg/277hC8vaw3zua7FmMK6FvlzHMV9tJaApz+qMcKz
4dSnmqvZYZF6QTj/nSRKMEsAKqTv5D5XXvKkTZIrB4OzL3SdAtXN4lyPvJgnzQryhf41RIPtOivH
CGXDUMFaQAqyDiN3Vc/+cnqKrAhHhHhaFOEYhGtNxStGcH3kgCrKkcJnGWvGWudWfrTGVAhXOAUn
SQ9pWHmtLKpg02btOK4TEbYYdYxTQkMsMhPc2LL6DvrsmLnaYAUrwkD1Pa+H9JukRfouzR01cmUB
wnP2Q6h3Tj9oX6c4636ggwXkOAyDjnZZGPu1V8eKHWKPJUnAy0TSPlW97MQeyrT1X0GE/KKr9pNd
bpAxQHM+apuv/ZiYowfdrNTdQEvwM+F3i3QlgJ7qVJT1sdw5bdTAJBDpbdKXfuraZTUA8Uwb4z6S
J41HdwGhxC2zargT6CQhDV30fNCWrbtpZ/U8isJgzX0eP2hYBeNdFcFaBl4QNRkiip3BVg+L8I4A
HnTeZGjoM+rTGDz3lNsmj63X0RDpmvhTF8XDS+dn4sUalV4FkQ70xEVdwUEyKZ6c+7HGB2VV55Br
b2YJuGPSoq3jjn1Aqbw3a1lZc/IGGHpjG3u07pMvqVw2340iummm8BuAeL3dFEhHQPrzIfHuYqsq
5FUhoYuagkHtV75SUQBNuqGowBiFubgrhA6dRCmtbJurUxdc15KwrBU9LOlLO2lmtA6jqbqvw1bc
O3aHVwuLecSR81NqON94OkbRymy5bJDeJ3LEXdZ+QtRiwjSYDfxUtF0RIqbK3pKTAIVfM0DRwkuz
1J/Wdtyq4bqNw/AYJVrwFCul+Mqfx/CIahTfaYpH/3oKkFN1Q4nD4lLSyX/luq+2rtJI6UMKOvKh
rZOyZlLJYLrKiHrJypGkLHD9jFzEFbUxYhQ4aca9PaKUmaBl/SkpY529PUjYxmRtI1Vru3eqAJcM
32cziRiFSqRu8Lh06JL0uHHGayidRQMNhvxqSuvOcodSNMJrwTLlsKB6hAtke3B2TZ0rT10XYJIZ
9J3tmkqRKl4eSP0NmxkCp6UVVoffTF8UKzNvBstNtLyB88kRd8fMzJ/Ssqw/FySIMOU0Z8DsUFBw
9lRI5bLbFzgPrtWyUx4lYdh75Lmdf4yf/r/G06ML9iZfm/H6J4D67c/n6scfuzqZkfTzP/vvqzx7
Tv793+q3cPrXv/UPnl77k14N7yJUlMGLoQzyL57eUv8EH0FTkrK0Brt4po3/i6c31D9JjHltoK0A
QwbQ5//44188vaH9CcgAahDlOPJWxAF/B1J/9rqZ6wY4uPM4pa8Gtv805zQBa/kYoUg7yWhTZK3t
ej8p+V0Y5ddBkfeb3k/yq9YYH+C9PLxZwLu/E9sTYP1c3DrJd2d9V7gEs1oNnpczo+FtvcZpkF/L
HT+67uK6uivk2sHqsPfzb+Ts6XOSCekebe983VngXzDMHsbOoy9GYodp6VpkOfBHvVBuItKgwJsl
um5CkSXKpkrk/BFHtUCsLI2kS2tbHWZjMUT7EU7aL0FCcBwpOP6SovZKT6ah9XylnYNO3O7NQgm+
Z1X6UOlK0XoECcnG7kiVHkcpC+8SJ7zKshYpclODu9SpPTJmhlyiGSQkX/5sYTT690r91nnah9+r
vM5/NadklFNSy/9zLBa4PW82zdmpQ2KZtDp9rv85eSeHbP6//n3IOG9/AhObq7icGmTw/3PI5n+D
VgtNAUB0iGG9PWSK/CddGQ26PS9AtBtmHOO/h4x/N/+tGeg6l2/mv/gbvJVXrMybnW6Cr8AIB68R
jDbwkHxFTL6pTDoaiinQspVtWdTaNZowVe+WUmqJVVEYK9S5y4kUJw1BL0daudEdCBaVDMG+0/pP
aVXZuavU8gs61cVOmMEdr7HRczr13kl0kvGuiarbUkAb6QJ/+t6Vg+JRHcGplPZDttP9ep93ffy3
NeZv7cr/2dZN9ZyEz9kfblv9fG7/yH/9cWieKQtCNKqXe3X+2/+hVf3fwaOCdv3RDrz92f/hPSc/
f+RZSDn6b2rWzL96/f/9s/0I5URievEg4GEnzZKGf3Om6C/8Oe8wIj89zhlM9V8xXrH/pIGPQh/G
AjR96U7+1/ZT1T9n2XR0Nugv0eYB7f0b2499/DbOggyh4wlvCjnEOcQv+YK5bTUBnQD/Pi1eevIt
+ZvIL1BjF/X+v4dgnvxialRngnsSmjij0Af/XgtluEmPjROudedZCY5Np7tvPsA798aym/o6GHXq
GRU2H6YlCsUPnX7GQ0v3Pc0ab7x16JyUVzaVqtBL9W12pVoXhnxvenNbfBYUo0O/hIHIUaMUOlbA
9+2v/K/8QT/AKbk4yKKw+TqtGTJECQjVHzD+p9cheXhva5nh3xeR7XZWgLp25elGtJmC8PfnQ04N
3IvODE1pZzGUD8QnAHLv31PU9yT9oUgezaJwVQdwMRW/j7/XorY/zwsOEhB1aqeE2qVbr0VpoMgp
dBwE2Cuzwub7UjdmucHp9bC7kcWaK9CcpUUS0zexyAYxBofClz8h7ioHxkpq+/XH81jU10E8n46y
KATrpWp3YzAFB79b+5Jrat/8z+amsyvXumSDtFyyeSgAR/ALOLkI+S0mpNQBDixOIA510VVeHG9K
Q40vtLBeV+XNpfQ6H24kBVEEB1zNUiVv6DUti6iZHaofdowQiDcWIGR3w0u+U18wXaTgKQZX/YZM
DOjH/vfciOmzzHMEak0JWEMic+mppKJFmDVqLg5d8jDq5UH0+TZX4u99WVz4cMtq89lQ8/55c/1y
VUFc7ktxwPgd8zHrnjfr53Kjfhr26YVy/btf7s2sFl9uftJbKQL1B8XsdsBlvaD5TXDSPBuSHd4E
KCNCdXsta7+ZjWwiauokFbORUW4fjRsjRKIEAc1GUbYiuxT7zg/X/H2AAr/SrLDCWSxebWjFqKnB
YRAq9qwE12ZFoeHjs/XeIHN/A6IDKFxYBaeDoARNT6IiRuQi/iWpW6zVH8LftNmetxwPndkviYWj
7b809InsDL0MoYpD2RjRUVewtBCWL4nfDHivw2C3QkYARersMpSHsdLwKBEHO6X+MpU2kO78klDD
eys2E7VJLdBIJ1c9XbHaSVDBNwOial+t2+RWJOEdHiIXmhLn25m+CGqWDi9UWvlLifC0nMzJQLH/
oCSe0sWKV+nSJUGxZXY8f5aTQRZTaUALIGnIIKv956O2VXXX+dZ9pnLqBduX+7vJG1fgolfFtX5T
DS4W1zej++Xj/ffuPGemBRRLqCZLDDa0vVwIAC0HjQ7pjFG5DbJm/X82hnr6xUSdhI4vl3wxPdna
4wAf40Jb7dIsFh28MUKaTzRFeOgbu1oLo1018KkuHNX3B4Fri3EtQIRlxaCv6UPa+OEdsrjaRtRc
RXahEXlphMVF2wC/THnrMwIBrpYDT2QXFmohkfMaCWZE3n8mMd/1b2KoZbVO1IdDeKg26hX0uatp
FbrH1LNX4U+/4IYIH+6+W1f96nZ0x5ceSPy97el/P6BOVCdOCiAMcnoBs++hzVJ2pIqDmufpjzBE
3zWVPIWHNm53wRSvAin//VD0dohlizMIS5DY4RgenM+2HV7V2SWRn4XEyj8riVYWtHaZ8L182upl
YUV+r3F4X2gsXeG6tKmv8n28N279o7X+/nS9tVZ8R/M+2ccbdZtvqiuxHt0f/43D9eZnLO5dkUZ1
EMZKeLDNQ9bOaewlBVJ1DkNnn+vNEIttCRAcT7fYCg80kK786/FnHeNNBgUQVSXLM12k1tfJurhC
InN2OgfD9TnYXMLMvns2KE0AwH/N3BbznJpICofeCA+BWV71bZk+S2rp//x4Mec/cjZTiB905vHd
O2tEN/RByOPN8BDmt76G8IV0M7aalw+XICvvzubNQPMl9+YYKpnk9HnHkoKB86jU0de9NMS7GxSs
D+Qw/kFsbREUByqCE2ye6LB/Sa+TjXKjfAsGt9ta63I1eZqXrjIPBvW6vQlWidcid/Gl34pr+Wb7
37hjSOgx/AUvxq9ZTLbNQnKCKY0Oel7falF6OyiXsDivvnWnX25WSpzlmknaKBAv4pqZtyEiPTGu
1Vln/awnqTso0dBULgoBALkMvR+eOsy8fxVDnzyOE+7tdawlD4XeRXtTG9T7EGeM6wpnMGwfR4mO
cB51/ncbXTqi4zS3VtOoKfetH8m/hkAZv3dmKoeuiZbdvpfh75DxKBqII5u44IqqkzDbVmv9mJRq
jrJGImVfYM7Le9X0+e8GGF3Hq1OsbNw4KeyYBvqoD7OEL0xXJ1SyWx+pe7w4tEm/n8pU7JFtN2EK
D/agrQc8eXLXTiqsCtS+o0UXVmofrvRYlInrIBriI0/kT9DDDSV/HG0Z3TuV8yXT6UaYwLUxe/71
8emZ48DJN1BACylQSCFkU1xfym+kmV5kYRh1B3jFt2Nxn+vGrwk5/0w/cBf87h0CoYnHAKwmdb6L
l4DuKQxj0Q+BzGCyayn4N1QXgoE+5yUn84Hzw65lX5GZ64BmTg+pXOhqkOZ6eLSR6afF1CTFk4ng
7Q+gwU3t2Xom30taJXWuMWiVAqzcsK6rSES/0jAO7lqnJKVSmxjEeSaNSfXQBl0dvcIWvvqNz0sT
pav8h2+r6Z00DMWvpjXlH2o9tX+NuPo6ru93WgjXY0ADJ23tAtPkqc0KFwpXfG+WDjhWrC2UEWHT
IbgJDDX9YsfO8GALW4OYG5X4hhoCINcaZLGauRXEun1QAV1xk1SJjauB7rlwaQSGv2nixPVI5AGk
TRcHy625one6eJZU1qIpu/AogVbZyzZaBLLSVh7abnnuhn3S/GVatXRt+zl8HD/Q7oMs+A4KoV8L
x7xkAvZKzT79luTyqFnwMJntQc5+Dv2WFmJpfIzlGBubVAlWg+/bW2mUi3XeKMENkHcg3DCiDlVR
WG47avmDJgNIcge9rdd1aXe3leEP18AlZW/KE+ngFIHYOJgOUIbrrYPvJxupH/O9RqN1Iw+lsklG
Y7wmIuWYbrTTvkssZyV6nV531Gjrj4/fK3H/dI4oVM2QRAd8IFqPi/3aYwZcOY0iHx0rmYNArje/
Ohsuq1vkinoTIqDylBbdtNOUSkKbKWn0L732CiKRUfsNeOweM3usnltzGu/AG4iv3CvKsR4LLXVH
fFhHb8z74q5JU27FkZRA6zzgecoRDEX5xQhj8jgrbeO9CewodKcSZoDXOoH9E67H8Ciqmh415Y/w
Z4f7WeGZtmhlT0hlibK4GXelF8rSALixhvVe+LnzTQJucgdc3YxdOerUxu1SK35Uu7D8Tsva712l
KOSvJRXMQy9FzV6NaXm5nelIKz+JLRR4Pl7ksxosG9qxKNoAN1URK17WlEfLDEu/651jWzs4Czdm
lNf72sEizK2Ttju2YzyGq1LURQQCivqc15a1rV9NgHxoto1++/XjX3SWStDdQRKMNg5lJcjCi+xM
Gh3s1rUuPmKzGuy4KAyQamFw4Q5fajJwnpEHAK9P5Z4iwtnrRw6UUDLCNDv6fqG4Zd+aoE/Rn0YP
YRu3cuLhnpOOgXnlq7Pr6NTgZJv6mQdyC2U+0Rt3NWdw89tzR5xmhk7j7jo/10+DTN4Ewki1Pjtm
aMRsqiY31tOUXjLNPc+kZsIhFLXZE5lEf0miwiRXEcAR8mOSVvWNMGX/1pYCc2vPz+VijA9NXqaf
lMDS130CDmdC/2OdBkbqtZiaraHAD24J+s8boOe4vY/ZliJL2mpK43u7BuvT9kO6NTEK37aAbrad
1BU3jYF0lR3FtTchBLDmjg+92tcuAezn5OskaMxz48amE0i/hrBxuoSBHRilVZf5scecZVWbQH1r
Xaa0Gxvi6uOvtWi50weEmoBalWaxi+gmLK6EZmr1Ti+n/GibTXRD/9tcWwXy+0OEi3CXYGSZdkl8
dBT03QrUDHcfD392UObhgQ9YEPyoUS1VRUwzyf3RbIojKaHkDebg38ogsy40hF65AssFpbEwZybw
zeiLnS5oAdyuBhxVHoGTCg8MDKoH8dRM67g0xZWahs0Gp0H5Pkh9kxte2VdahDeUoktbNUnGawQH
UrcYYui0zaCC5QmtX6GEblo8lYObkb8Kbu809Gw5UDdDkQ2rj9fpLI3jTctGp7o2i3Aor9SdN28T
9LYy2v1deXSGdvIUY8bsyzigGLVxaAoD5CxsnI+HPOswvA4JSX0e1raWpmVC8wX39lQeY8nQMBHD
XN5uJm2NwgtrJLWWS3zloRknyoVmwHuTRdEf6VxEdCmALb5Wo9JMDsqpOjox0ju239jIxE9TstaB
La1iWW8Pua1eUj54ZyuytpTbaHsx26WomVylulwrWnWM6hzL9CH04S+LS3Kp50ebhywPP4eTRxa7
5FgpQNmags11xMw1wj1TvDSIW3gtYj+/vWU0EDvoZnAJ8QJbUpTboO4KUxjaMcg4Wo4DjJ67froa
JRTKTEAGqGVowYVNszBgIsVEn4zUHKQQGeYMaT89aWpgI6DQ59IxCgcAMbC+6w7gtOPjBdBgqe3Y
N4poj7P4ZOPbYBY7477x9cL140uQ+vMPyruWcrQ6Hx2yzEWJs9JqPcSfRjqKhpYS/o2/hrD9B132
vy2bzXvxNLJgaTcbmsN1gVizbBwlmpxikovrSmWVztpUc9waVfShtNxO11AXggvx+rWhcjogegNz
M553HVSBM4erUbcl2WisYx2af+WldhX4VexGuvgy+AcM78CDZwCXWjfMYgXYOpbkcXnhgJ5PepZl
teFm0MTnuMwr/yYaURDiyYnU1lHLHAMX9HG6RqHfoh6fj7Mrs3zhlng3wYPTM7/4ZquyJc0mzbi+
uC3towhlcNz4IKhPGSiGu1qdos6taKbc6+OEdXyiDcbkIQPTi40fJvqPhnv/UiHzvIdHwokCInVS
YAYzKu50ATpEWLHDjJxjbI7NBrEmzPTItzRXKh1p31aW/plCmHSTimja1xrP/KJOnW8fB+jz/U2/
9BVohCAE9K3FUUvLZOgQ3HGOcCodVw4kaUZa//p4EOPswY3Y3StVfSbGGGQIp1MdK7lKQl9PH0K/
6AD8dym7246abVFNyuQZSdfs5FEo+lWjt3rvxaU1xi5U3JxeKshqXLLs7kUucI/ydFiYwcrWeyfx
CjBsPHPt4rOc5KjBa1X8OKWYJbpGW1DjFooRIBFv+vYdT8TsWyGqfpglDStn1av4tY3GEOMTMVaf
cXOu5FWTjC3PcCnsdmobCVC0sS995SGvZl4U1s4TIpld/6r+9L/YO4/lyJEtTb/KWO9RBi22ACKC
DDKCIpNMsYExi5nQ0qGffj7w1u0mEbwM4yzHujZplqKcgB+4H/GLwkNrFZ9VKa0lpO9n9aF0ZjDc
+HvLkivg3PKTBVUX+oWcGGIrklib3AqZi5tJBVvncRLg9hRV5X0m1/Lzx6/8nWjH8QH3U/Cwiybc
mqAfab0p+rqtHkLH6La1AyrfmTUpc3Fm1TwduLlngIS8sJJkb/RTvw2TKn2og/bcWO80whC0AhW0
zClhS69dAsq6yi2kRpIHXEfCq8kMMXnRzebckbZUBG+PNJahUkLtAUtnxObfhphsCFlp0iB5GEIr
uahj2b4KLTOng4R8yGK/fBHYsdjEnRTdK91guQSa8D9+6adH2oKrA00DNAmk3Zo4iCWKqc+lGT/I
OMsdGGaPD8PYyEdw/1+1aWzOKRu/sx49c7iReDBwPa0T30q1VXw9xvghT3HUkqKwv5jV5T7EvmJr
hNG5adwpwIJsAJguAjIcXAwXV6cFjQa0o/Fdf0ATtr2YxMKHEHq4WfR10Gipa1qlAx+fU5ruaDrZ
tgxszcfhF3tUu4y80YqLL/DPxWWESoafULqcmYOdJpzLT8htQj1H9bh+JVhzRB39ueTBVtgCo3GA
U7E8LMcRptniLjD2Xf1QxGfb8u/E+QKvBOlEyb74ha4CsEY5D8R/8kDjDN4kqe6W/uZw5tZ85+q2
LZBiYIvRTKAru7o1zEge9d42ARNYNNMQ7MXcCGfrrUHDYoc1mLatektz09RsriejS/cGfCu/iGTN
H0BunIn4ZcNXXx09E8AbtP/B3Firg71WxrqRiiJ9iHPnZkynP6ZdfjWD8EdgJUdR9r8+/sBOE1+y
UZiEUAlpaZ8M7/FSmay4LNOHYTaqK1MKjXvJnr/TSFXOPNhpSQv8kQIaQwLga6QMb3ezDQMjz4Va
PBiz8zMN5fbWQSDjmAxIiDWKGDaoUw6XeasIP8bXcfPp56RuoSNhI9oJG3MVS3YHPyll0vlgzZa8
zxsakZVs1hsU8s5hDyH+nuyhI2Mmpr9ocqLMuEpxzUotk9kJmoeKT7S6kPtY82UbDhEStSJHdEtK
K68stOHnbEyavAukxVK27pLyqSizpLuygizLdwOiRSg0ItecumpVGl8Uuw5vJ0Waw42pzepWM8uM
UUU8YLKGyMCml7tI26DdkB3NmJ3wVfSnn5R+0P8kKNZd9ErV6HsTivvTmAZt5WKBSmVtYUSFizMW
9wHfMhmBHzZ2/MMpu6nbWQPYv4Ha/JetYvHs2pg0347dpP8qwtSJPewWELU3NYQu28warrWqcIYl
0Zjug4i/5/Y0Gu6dIoFsRLGDby+01AcRypNb8Dn60YJj28tVgWOgwaMJ2KBGj7S7UbWm1w+Z9UWU
Rn2wjM6wtxEekj3JgoqmlFkXueTCu8wupgrYBvh7ttiNSPEura5TISf05deyloI/lOGYbyBUJ+Mm
VEv991npmDnNRppturKTZ/Bz1ph7cVHyOzKQmQHi3gItkDHLk3epslC2wrKNOk9GQLNy53aKSHPL
wdo5EsMmdoEhBdyAab5pwlT6Udut3HqFrvQdAKJac1wGTZPtD2WiMu8xFvtL5m2R6pIxYrJFIyzd
mEVQfZuNwMQyrafMxa8yC8xbjJqZ2lQiUWHmOXIH286BhOUjq2oGfhqZGTzCvim+cVK3pd+pY2a5
Ni4C7aakI4YQ7FBPV0iWOL9i2sq/gl7PUTUII5n/UVOaGwM6X41TXD7DiizwB/E73YgvY6eD1tBD
zXzgjlBzt8/skqrR6rWjQ3JZuFZWUiETGMUPiJaoeJT0zPHaEhuOAGMfYvn2dYZW6oVGPPrqrEPC
GKNgnrDjHI8v8pQ3pkgbzbWYRxR+XFpp4815E987jPS+oJ+ctNiTz+E+wtLmANRpekrmVDc9dR5z
GwGKbpZdIVla4oYdgrxCKfLftpEHiTvS5f/aOIHDNtphdNfy4f1AGMeCM2bXt1I7Zb87iI/Xjf5i
8RLq5dWIGZHjS6YIf9WtCL8xspRM364K+XYG1Fy6QsQP+qCnOyWrSyz3NKB8HtVf/miVendVm0jr
2XUVda6uDpFNh0SOc68W1fRYTvQUeEXpbHpNpEPFClVsjicHSqQ7ktd8Q6Ogvi9TVf5Zi8ZpuPvj
5r5uGku4jSBJd+egNw5OGzetl9hztK10Uyo2SatvmqlNHyZV74+VEg+SCz0NQchYmdGtMYCWsYI5
xD8LyTZvwrkIfxVQ6Pn2JRSX9hlWpWy0c9MXtvk9YBrekPJIMLktaR5/MkWlcwAjHAUFM9QSv8ky
06GhppS1H0hpby6a9tNzbTvtVT8m6oUtBl7DVEdeChHaH/pYvk4H2XyOGhsPgKjstG+yNg83bAeR
F9L6g+0sQeB3y7DUHmP+TPiOXDq2F2dm93UeSfO/psOsIDXSOvPzqKQKrt9O9hyqTinBtKmqL06Y
WZB9xfzLMkaduR+EDq8t+mw3hXhshrpW0Ciuq/lPjxWkyKVjnziXjpxjfQgD4tlkeuLrecosEjTA
t1BPzdojsNXS1VpbO0ghlQ348aDe5/jOyJR3MTIrra1MpTuGPa7qqj3Jf9S+Dm7J1oYvYSBNj5Af
p71TkK270hCYpJN0CWlmRfX0O7GdmddXd8hAjganflWqo+QtzC+2LMjwZA/LupZd8pck9PWZ2OOM
w7AUEf0+uSvsNL6Wh6RUfPaugFltt/q3RjGC6UwT6RSDR8FBk5aMHEApBdAqV9X1FC/5TmkeVLWC
Pp9M5t3Q6k85AmVHw6nlTdmUBbqkRbxLtKH1mzwfvSG3sIAuE/bBtFqvDNTgOhBBfzCzKbvg92uX
2StWDGEwwtCOy10FenvXd4m6GfTZvpykfrzPG8281Gm1nklKTtOfpW2BHibwcwvJyFWfPeGoHScH
3ah+hgGbTiXC3ZGEe1NuGmfyzCW/eZvYvV7qJNNyVKwoQ8lqHqYuCjdaPBi+MyOD+dk8B09zmmrM
nzADAN7xNssaZR2NLdkoHgKpehp6p7sJbbv2NEky/ny80jvPA0oFKD3jrkW3bRUNFdjsLozN8qFZ
+KUjnU7XQDhg9+lVSKOWrJyMivbnKh1GWtKuTczGHqKRc7bNEAFLTSwuPl7ltMZxUNAlP6Sv/UK2
efvWWowDlDqd6ofAFPk+FIbqlbad+ZxK6JJlkuN3Qz9ddKFxruB8aXeuwgI/XppiQABQT1uj75rR
1FBtz7qHlL4RtjZIA15EehFuYC4bgy+Xlp0z+2hxkxuniWwN0/Vp8CQtr7ysEOJGBHJ6UPVEhcGN
YsBeTq35iTROXE6WQJOpGBTMlhleNDCTc6O9cchALJ8X0oGYGZr4IQvbApa7SmklFHzrXKZKWbSL
UDTDVRrndOwsRsY0bosB511nZmZ/5v2vYwl5M0aGmMkzJbZBXK6Gk5MsBQzO+/oRmezUKzs99qoW
LMjHu/xSyb1+16xAsOoYXTJ1gtWyCtm5bI12UoP+sXR/+rUr3NktPcur3D9YUHpncR3rw2W93Cp2
TbOKcbdmOdkzXGQafOHFG2nDgc5ayWYvu/H24ydcqpj1AzJbAL9hvrhYLvDEVx1gsgEgPtB1H83K
uWk10nOtSn7hSfVbEuWZ7u/pntELeLXWqsgJEicTqi71j31+rRt/x8nXj5/lBR7w0cMsVdarh1GV
gVbiyOu7ctzaddzW7za9f/lL9zLXdhXvPvJ23C++ukV325fdMyyNdV+AEm4RMIYMt7xPfEVW0QIf
pDQLVRsf0rqQFXQWyole34QGk1elqtijvQ2urCqSVt6kZaxWIMomKwLhJGf6hsLBuMlkMRdnKtkX
ja5X7+Xl5+J8JyFmZgo3eVXKoqsYBVJZTw+QQcfvndJ2qJBQz1pSNF92tR54eP0E91YZawyUHFjR
KM+7oSSGm6mozG3nNM1NXfd3gyKy63ZqWn+q5dCP9TS9/3gPVzHy8qMuxG2GXWgWgQh6u4UzRSap
nTk+OLMl+d2EJvI8Ul9+vMoq6vmUFbqTC2RysY9DQfTtKkLvNQlJGusB+Vb7Ls4l2Usr0XkpvbeL
wBz+kWz7FKn1/1Oq9UIR+c+Ogce4+/2W38pf/xe/VQL/9xddpMVQduFCM3b7N8H15Y/IsLDNWOCH
Ch/VG4argxoU1NhlB9EoZ/P+m2Dt/LWomALJodcNJ5qp5ScYritsNpc7xSG9JwjgJLALZPltmMxG
ZoWZI1UPsrR0VPpIbqLNqGn7DNEXJp2zVR/bGPSfm6sT/ZiuN5GpalRlx0BgHtwpHhNQV/kcXg+N
E/bUCPnwPKW6hUVOQoYi10MDprUSh0rI0S/gNem/dF3/N/L+S1nkKj+IvKeu6d6E3vL3/6FWm+Zf
HNM0ih0kjTinuYf/oVYvf8JgkrMHNA3MaoLr3/IZkPeJKxwn+RewG7nIOJz+HXn8IaZ4S16rw3xF
jxl25f976BF1cNYWEjLzGkalnFNvQ4+kB2GjugxuwVfovhoxHBXiF85r00VlI0KcqhLY1UWD0Q5p
6PxupPqrJM+9rxuz72SageZUE30zEAjKnPkyRt7XkwMr9Lr+b2lWf7282v+Nsv+i7fxRlN0+Vd3T
/1no/LsuLn4/vQm45Z/+E3CG8xdK//gLMCVaIu6/jzoGJH8xKgFVCqwUyONrKQn+hApzCTgCEqAJ
QLL/CThF+Ys5G8xDCgCa5JyEn4m31bVLGUNaQBbNLy92M6t0etBGoKEQ/q8FE74EWHwr/SlgAly8
ejm3/0o5XnOTlqh9lYgsyzB4BkuImSuZ9brNjb5SKWWisq+ltsoeAADjrQaw8NhURfEtlBT9W9lK
KhDaXP5WR6Z5ZjB1+pRYHS7q+zgcqIgzrvJDCe1XYRRGeCjkud0pqZ37+Tjcf/yM7y3y0h8ge2Fb
10C8SLbaDKuO6ABKDtUzPlkvU5tzjB1OqNWbXNiZDKBgtS6/Lj/Fq1RXQs0LU+04Osi0AWndFTnG
PzOTcDs/Jyf93gOhRww/mMkxgtKr2Ei7mrBuuuiQTEn3t1Pa0lamu5K5n39viwcfJe2LrMpqc/D3
Myan44nGPm830YCqVGak58Bw65k8IQjihtngsjvUz2s557gXpaT0cnQInbIC0lFS0WloLNNm+j2g
fe43wrQ3aPvY22GKMI8Z53LT5Kbz+VikIweuirEPMKt1m4KhiR5Igx0dImF1+8gGWdzNVvbz45e6
SnRfnnYRLyCBIS96UQN5HSbOhKbZSF/wUKfy8wBawXXM6s6oUAKc1NH0P17tnUiBIESccFRRaqxh
Bh3vvIkdMzrEnd6ht6lhnikQ0fh4lXdCn8wMN1v6VSiQrIEsQRP3ppo3yUGbx2A3Olnt1/n0e5CD
c4Pek+dBeHixUFooDTApXzycX31kedooNImT/NAWKSqOLCwuAkcoZ06Mk02CTKkDwLKxAeUre6HK
vFoGWGSe2lbFiTHnsW+GefoMQqN1zS6370pwUZ/dJtbDjmrZIFSrwda9PTsmBdIWw4EYNXzMpKOk
hN+jgXL7eJtOX56KaPpSw2lgyFH6f7tKnXVDbSeMjUZIUpdzApuhrNJzvIzT7xkyFBkcgBk+aTL1
1elUwmLSGyvID5WJAn0zMhhL1Hp8ZjDnbKM2VG+mub/T7Fr8qfqmvAnUHtTQXE7bzz4uzWC+ZhW4
PKJQL/46rzYxNrKpVPACOeiRPm2iTnrGnPYcevj0nfKA8JaW/oLFA692jvZJ2dUxH5gTtN0mKJrY
hzNRfzo+3q6yOolLEaKXq03RASNix4tUfSSZtM/Jwp9GPY4afFzkHejYgb17Gx8TItdWH5X5wRqM
+gJ8itgirBpfMpqZ/DTX+jMOFyfHBlcY1wvfFxp3YK+XP3+1QXJpDzaIRsaYuWJ+QfOwD1y1HtrH
FBjkuYn+6UZxlXEMgglibIlA0tvFpLShlpOq8mAyhLtq2wDngD7LzrhovLsKHmt8yMvJsR6vaOk0
YkE2lgdbAWKn5THw6in9pM0ZRx/PYpH8kbzyPa+TNjtCz0VSjPJQg2etvF6VuvyqnkUQelPbYvH2
8Ye09Djf5IhMVoDvAK2h4oZ1unp1FgAe0c9pdbAEavSboJ6zxyxCGHiLB5h9DPHue56kzjyMlRSL
M0nIaVCSgJBny+C56JuvFw8BfJbaaNWHsm2Vwk8Zi4duVjTJjyjKtJ9RJkMn+Ph5T+KSbIcSjyMM
iDPLrr5pFTyUqNEuPYSjAdYRRdLbGQFTkIGKcSZe3lsKpwfyX2Npnq9zDs0KY6PoypbcRxl+I58j
H+pRG3ZjL/3Td/iPcOp3liKvoenISYj+4xoejxoshN0i6/FesvRLXVjDLu8ENlRSEHz/+AWe7NlS
qCNbQ/mEmysMlLffWumkyIcYTXdo7Fz4GRu1H8YaDK0tIQGttPaZzO2dRwPUSdVFoqpAAVi+ylcH
CZgOeBqO6A6SygMtdBS/aIrBG6vROlMvnXwLy6MtjSySAorDNUmW8GtGGdLdYdGnehrkDInskO75
aFjDsZibMnZLp4fpAx/qzHF5crYsS5MQ0iJZyMCL+tzrp5xnNY1aoXSHIS3kbU1r+WehRfMZovHS
zn3zsa9WWe2dWcd12Dlqd9By+QeYEHTh9di5yKUy+Jok2YD2cjJ8Nn98WZP8mh4i6L01H0bDHmxW
IZEeBjvFrCuWvtdJ1MDincIzOcG7kbLgfint6TSt+4emikyw1lrdwany2StR2nUFlDqPeeS59OPd
pTijX1D1cM1W21UM5dhPttkd5qEvL5VSlr/LgTzvY6EXZ/ZsPeaAzkM6h+UZza5FYXA9MRaq2SP/
rPYHW6qhH1amnRxnGKZ7RTPDg4xBQHExVpYBNQttGt2tQiSrrbopbuomVe6ayMjUM4foO9GKUAhl
FD1jhax29U1W8IFlLsP+gJs2aKBg0Pd6H59zsntvFY1DbTlmFibOqik3x7PUzi2rzJgdQhHoxm1K
+rn59HlGPU9z5EU3CDGzt19eHOENNTHJPahI+3sx1+BObjCwsMAPfe+ESD59nim8NYp71O4WuOMS
Wq/Os2FyIiG18nwYEqbYOK00Htzx2gO9dM7H9PSoJmjo61MUUBPwy9ulJmEV5Qx27ZDIDcdWLoSq
uJVGH8OXIHkHXoaLwjlJutNDFD1kEA58hjCKwQW/XTS08gBUT+gc9G50pkOiGCLeSW2RNZezZgfV
RuBS0aPAi/f1IaPhYp0JztNDjuqOeRM3Bl4rJ6jkLlLlWuli6WDajb0fQOLfTLkkdrlQ+txNhDTq
fiKCWD+z7mm4voBUsD8iNWSOsvxcrzbWwOMbUlUZHPDJszcIK4EJK4PozB11uspyO9DJQJKM3tr6
NJDVACOZ0g4OQdrO20lXow344HNNqH/xU95cFZjWG2haw743aaGuax+jkvSMjVZv6p4Xdjdao6Rv
hD0Y9l3oIJW/XZqkKgLosFmuQ6dRdUC7RVkyOK+cMd8mkCB6L1dygMNzMMsm2h4N6ETZy2GIgJTu
NBoimj7I0iUJTaP5BnITpZtrMPx8o+uDR8ksJNo0k4bUVloFleojRFKykfjzFW5QV7XwuxGPBl+X
B4wDHIATxs8mmfPJq4J8/pYVapzepl3MN6bGlTCvikDESQYYLq3KL0rcOVDxq14ztk2fd8lTnPZD
u9V6VQ9uow7M200Kj+WPIRqlxxIhk6LrokT+4VItnK6967KwQn/GwEvA1Wszky+0NpdTP9E78T3M
Z0T0F5P78Nq2gwxu8KhB6TMBheZulJl2fx0rWXUty2P22LZWo+G9akfxV3MC2qmUZM1PozZl6jFK
RRXfoD02Tpu4mO2fgrbSN0mlgbWb8dCItgLuYLib0yHovmVpnUrXYzImFk6ZAXpUG3ApgXKX4PFR
u2UOafVm1ntp2MK0sJ40fVJsP8oBql2WhVgQg2Nnzxe1VQ2zW4P4YvSMXoHl9qWjt5e9nsRI5jdD
Ym8DVRq/gP9SMr9CPft70+ZVhGSLlZcboXNVeVqn6bkfOkH8VEULoqUG/IQlGZ3cS6kN08RXhJCF
W405bPMcG4hfwaCa9+0w0hgknexBz7V6GW2qSnd+921m49CL/UTsxS1Vwy6Igin3Z1Oq9INU9Maw
TWdrUPgpBHniJqJRgeuKJpmtV0vYKfziPgQmjZdAFzI+zIza3lTWrMVeKTnlLxOv8l9mU1aqByY5
67a6GML0Lm1iFd8UfK/VnyPtuOg3YoeDeiHFhg1sJ5Bx0Bn7CLGNKDSjbjuPempsLSPJ5MuAobiz
FUY6KDCgUgvaMc26FPMDOarHPVMpYV6mrQav1DUyu9Pd2OnbwS/aWoOflcpS5osZhDAGGZgXX5ko
byAekTUN4iqTUoutMyDetY1T/GM2mqpVw17gXiyEO2nGWFzZxgAtqJYMwj3pRR5fNaLIUPcypVZ5
HoBjFhXik0lUHboxMwavFEhtcF/UgXrZojoa74wkqKQns88Xs2jLyfrFXqXMdr2IAUoytzXvmCJE
mM3BmFFk1wzq0Lg0nUgNt1ZWlc1u7gC0X8Yp/9idEqyfN3PTYqRWtUMk77kpddM3+6zGxUeSY0wl
O7m6NcNiAAM7MNy4EU2zGDePdlH9TDBeoGXH2KEpHmelN4PnWWmL8PtElTSAjc3CsYKFJudRd1nN
KapIrgRKVjxVWW209ylf+3QtVVQ5uxRrrPa6rTT6Bm4SjQHGGPjTiGdg2oKwKJJS5szaykUhzGiP
v8fEQHD4A3L01wjpzEuVDH3Qtqv2TaEqv2Hg/Wgb6yZ0osw3K+PLNIzEWwCyWjSGvLEMkf8R3QjS
uFA7cF6T4xYAtnMpRP4m1ppuJ1pxhKv5Dft2QikOQVsl6k0bS7rlGnOaPEykKDgxOeW+66pdbmJ4
5ED2WtDwuasFYXUMamXYOrOuuwkuSNsE7DMYM+j4yhjVd0kgtRAXcOvI4vomrvQWKrUlXdhdiVZT
TLtOmgykoZrBNWLzkDQhkMvAwCCqLvXLTHVucN0qNj2qRRcoRf2aon7wU0u61oxWbEAQV1uDTtau
7RCn0SZGTpM2orZP3+m7qbUXlp1UW7uNta/dUF47fTJvxglaAMJXOLOpRe8Vino761Hid22h7KY+
vUKXylp+G5qumJudLSZxk0E0JCMOo41uFtVBV/KfWm4oXphMd7WF6iBmkmILJx1PKfTbvwdDkvrF
OH0XikqbTZUHFztqdW9GWbFramSa7fw3JnLbbAiCC701gylCwKEeFcFUAsLfhdJBDPAaM5+oBhnc
DeWXqg1rwDNJ25W3Q5448wVgQD27g/JnOJ5Ux4q055x0ur2ZhX180YS5ZnhmE9nlDfJLQ/H3OBfz
eIu7iGX4stSU9uglMr5dv6dmKvs/aTyp/b2TlmF7TBKsZX4PdEq0XdVIkfo7V4FHt9xjxjx/nQoQ
6LMrS9DY9zUM9+bvrBzl5lYu8yL2Zb7oZCOqLnP2+CfhRAINPLuXiHNrlw2zNu2UpMvR9EgUSrZ+
YWRtW5GFmJjVedApXsRdm9h+DijX6TykyLTrILT0v5XZip2ngEMa7ouQ6w6uRIJcT1nYypAg1xS3
2kUC8I9uI1+UUXkVJOvMGwMLdLoKlPF7n6H3fM3tZQWuHSVR6ktqmB4xE3KaDY0qJvOW6J3HPMpt
LlwQc8+OU1QqNoyA4K+cHIdidyzNHD2gcbDBqyPPr19ESu/ITO/nyvGcKLfYNlgLVEuFrP8p2qCZ
3SE3asXtyEgzVE+S+CdXuta4iDrXhVdJXbSPGmieUFO0OPZVzNHzbT1kMjwbQHwA1jsw32WHKNFX
vY2iv+t8ACsg99wq17XiFFyDNhe1bw9tJx8xdMwQqyviQvi8F5I3LMbwtrBEWD23gwgUv8y7uQKw
PjEXG6VIN2+LMZ+bCwcZSMC1o1Sn7TbIImfaNcHsRNfNGMlD6JaNoo3XSWuFNMVLeEN+rjaKdGmP
IaaycgOhxSt6E+b73NZoJrl5Njrg+JNEQU+vqxMuMDM3jDs8kpLQC5WuuK9wK2+4meV0uokQSxr9
sjaEft8VdtjcNnWWNNio4RQIuXHAroBjXZRHp9Ig1bfN4FD0G7VZX8TKoAS7wSoHdW81US/dLd5h
GfQaufpJVmDeRhlzVrdQB+G4STh28SYjyf9Jli/n+5pPkoJe1ZL2uQPKc62D57dqN44ydd5xWRiJ
13Zp2o+ulsZd6wVzYBS7Ebs40yv7KNB3aU8K6vV9KasuF3CHOJPCbeJqoyBPl2xsnbY6ItOmj1cq
1iWuqFtTvmI0hki9I9Hp2zacXH+mXk3iS/46Co66aB9FU40N1rzjkktEzVilnl2lEkIYYzmqfhob
RI2hN7l0X2g1egfWNHEv1GEAXwfBM8ExwdVSiauxyKpnY0k0L/u+sLByi6OEQcsYVmCNVT7TYQfX
SJsOijyG5bbCfX3eBUxvu52aY0jl6sAdcy9P8jT3m8Gs0kunlaLH2Mqbhd5WWl8KCC+2W8NZKHd2
FzjP+EOi2yMaNPcIC2R53KaawyfaJnVxMZHTF9ssAVDpaiEeFWdawCfVGg03fGNgbFNtwPZYld/0
62NbifvoWOCJcUxQmedsUYobLrJgk6vtNEFbHrQzq570b15WhZxN8sfQcT06JalPmxKc/9HiGrts
jCLeILxh+SitnnvAkyJ8WQpBRxoMC0Ru3Suhga4oVTtHR4ePxm0kwOATqKbYzedA9Rq1jM/gYk8q
RBakaaKpxCP9hTWWyQrRGTFKNTqOuWZ9DwE1/EgdHE4/bpu8uwqTWgCBGl7Da/CtXI9dNWpWdFRm
tRYXklGZwY0zzXJ0pqv33kJL+1dGrYHR4xoT3pt6j9ZfGx9rKHmXaibmDTpv58j07wUEZbUNwAcp
RvVFc+9V8V61IpIwi4yPYFbCCwcYAplmUhyszDzXIHkvIAgHUPTLGJo5xNs+QdZMJOvDEB8Nublv
M4djokjRH9G7H4x3v3+8Te8+F3GHmB7fFv3Xt4slZWQ1ID3iYyEy/UZGk/DvWYyNp03quUb9uxtF
PwtQ9rJda6hHkWGyq7UZzUlFw+yibfpAPEqOFfVfP36mdxei+cqkg2PjRIM10+O40Fo9PgZBAcXL
lCzzUZMH55Na30DAFlEeDSkJEIEW5Oi37y7jVtALKUkQM0i7b9Zkjq1fzlX2Sals1lk08xcYI+26
xRT57TpzXQTq3BEQVoTadxgp6nay7OjLZ98ag1WIYfityMsurVZBbWfiNq3To92MI+53vXydm2l2
hoN2Gm/wN+gWITkMPBNNgrfPstgKjrgZWoeuzLDGBCjjkQTBTCky9dMn0NulVsMMWWQ9cpyTxUS7
Uw61XNg3DKeKMzfFO8G2jO8AE9JKpW27+oDssMprvRicQ4UL72Xd9ZgKUvKemcKevjbgBcxAF3kg
KHzr0XKPBZSuZE14rPpoQJgyVyn59Voa3ax2ksfPRgLaO1x8DpgU4Ixr2Qart1CWzJ3wKGWh3NwU
YATzAyNeffvxOu9c7W/WWTVEcR3InUjKo2Or4oHYF9JGEb8lC6knKzDmrbDDdvfxiu+9RmAhTM6R
L1gOh7fRl46tHS8J+NGedAxU1XTI9yjpqfHFYEzR3x8v9k5kID8PdBjCpQZlaflhXl0ZkzokEjIJ
0THOLeVoKS3GwXmK9O3Hy5w+E+1iIGUawHwM6NcUDZqfSKuQrR5FmCU/ZsTstgYWfzHF9HyO5nVu
raW3/+qREjvDJs+c02Mfq/MdmFLdL4U8bLIsPSfIdfr2lrYyuoIIKIIQWRvdd3T7gnAc42Oba8Ej
jQEc/8rY+uywBabDMqVbDK1YbT2MyM1K05s4T459Ggtro5iD0903oNkwIUxnWzvzGb/7UGwV0F4D
KMr6sJCh31lGp5FFDAMdAWj2Xqt05pkjaZl7vWnN2wC9uGK5mRbEl7z6rtSl3290XLRBH48Ug8BI
MJGNDQyUZbu87uwhuU6kSDrqejnS/VByhAA/HZRQRQC1IbfEyNpZBYohEvpAU50cLUHLnJJtRtGz
K5PymxIuuhYfr7b8304eGMbcMvUgQVsoKK/DUg/1aoikJjnqnSa2VEEMOc2q9RbC895MuvYqLIR6
0ThMfD9e+Z0Nhem9jHTIcJf/3q4c93HsZKiRHbE1z3ynVvCqHdTpTJS+twp642DZgC+hx7Y6SQx7
TOW8bpMjXPX+myknOBjzm3Hoffw0yxW/fo/oRaF5yxrkuaunCWh1BMbIe5S0Yf5itnr1JbHCwDMD
qq6K/q9zZsF3zhObBIpvD/YQ0MflB3p1nuQWnujhIMVHZNwMuhxSv82E5OxbhGC+fPxsy89+8myL
eeRyizonVU+xGP0mehAf01B0W76JEOzooepV+bFM8NpN5v7cwO/dp1s2jKwKocR1wjvQjc9iKU6O
Rq/o25xKcm9Jo+QiOSF2Hz/de18A00wSeIix5HGrL6CJW3AbI+dYF7fZFxNd/Ksa8+P90Bay3ytG
gnl7UDl7kVr95uOl331KeATLg9IOWXsUjbTFdQOBW5wOTPFTc9oExoCYEaeZtKA9Nx1/N0SRAEIO
n/OFE+5txERRXk+IVCRHu4PGGVRahWohzstFrxRXpjzrPz5+unfD5tV6y1n7OkKrhsYWfa9jPuBJ
nVjZ77CT0OFDZXTP4Aol5DTLzyA63nujyPGDJIRuRKm5ypHRsI8GR1o6m0GA6ksS2QNkt674EUQ4
SZ45O9eai0t1wZj4f1ZbhQ5tJ6ZbiZoclUZUuj8WNconvRTcJl0y7oqkiJgp0gieWruzXGFpxTdo
I+cyi7XA6b9+jIUnCJAFBOW6z+ME0ewMMRJZ/TDQ8Swyq3iu04h+UmtpdGz7MuwzrzAZGjLCKoe7
xlCD2y6uwosc4dfLEZOdTYTpxD9k0f8InXsvAlREA7nGOKhw4XobATZKKP+Xs/PqkdsItvAvIsAc
Xjlpd6XlWpIlW34hHGTm0Mzkr79f7wXuNTmDIUbwg20IUE83q6srnDrHRgcjDWatj5kTTsf2XGoZ
BWJwDH12GUvnLx77eqdKc9MIoGsD1EZiDh3oZtnGDcO+pxHeW/R64Jr6tqShehK5rez4jluvC/kY
UZaE14MQXK8kXKUJ3Q7fYUw0h1CfRz10HtTz/Yt0y0NR3KJt+x6abPECXQV/atvPaVABnIGM2m6/
5PHQftTNsfi8OJ33wQjN7kkTYfQozFIaOMSPfDtI4pjfWu/PbDK1bkstDTIvs05eu4hTpA/GC5gT
sRMOyL9q+8gAKIHogulDhg43R8kD1ieE4VmwTM2PwsNUu1YsP1ph6N+p/c2XOHbn75VbFT/oebY7
GMGbd4hpbZ3RMYDcyC2ud5qrkeBPwixoyAkukFt3jLIsKYR/+lQ3X7I66X6Dsimnaz9q/0yF9X0u
B/Ncu73xpVEVur+xNS7fH//wTKEgAw4rHrGvNL//eNBsnhtKx4RIamVQPG1QWDqH9dL9qY/zQKku
L/+gq9B+VjTd3jmQWzbHKI/K22uDVtlGZ6ORDV6lAodzqnB0DjHSyrRAUvpkUNuoY3lUDIvGrwbj
RnXMC8/rd67WLd+B6rqcjDYAjW5LrQpc3yQDbRroC2RHAmjFV+aL0ldtUuCfV2Pr4sUDKs/3T/zW
GwmGn9kVSojyTq9PHKrHiepbnQY5KjWRb1VmJZtXsfI2UCl/NkptTyDslrMyqSWTSxH2Mw27XjGa
4ymjo5UGjaGJCMqgvvKO+aRAvgIdSb4X7dw6VhM6EwaOSOWJPNbLDUuoFi5kdIEGGxXrjOIvSKrA
7XhxEp/HcfT+jcm0vv3EsUredlADMNlcCTDUWW8nDEkG/TDRT12iHGV4nZ7rRQ5I9mej19qv95e8
da4Sti2rwISs23OdurSa4Xphycko35w4muZj3URDDBzdzD79xGIQUoDbBlBK2rY+1SRCyGIuO5J7
q8m/WT3owHM1JflfjZPRQL+/2DVqFa/MYijSosUIHm/T15m8shWocEhKTPIYJYXeTwHHeqIjuxxs
LToMual9StS2PDqpHh/nxaH9E7UQGStTvNeEueW4AeXxQoCaotiwsShZpuqdpMjovfbZ97DouiCr
YoqTxDtuYGSTeOthOrN9g77rR8ulCbDzdFxPTskDwVcxiMtLhQ9fH79gfEhYCj+hyVrz4CEFP31c
Bms+Im20vNWup0gZxvGXTuvMj0riaAj2aj2DCeO4lwfe8psgpOkDkZJRqN2EPEOUxsKImiyA/tw9
U7iCp9ZcIvGhr9353Pex97c5FflrXUE9uGMX8rtvn1CCUTwXU1uAtDd20Tb9HOVKlgdlATrVx2uZ
v3du2v+uIOfaHOy5bS/G0EPMt4x1JymUxGQB/mWSeidiueVlyKaoYjANgqFubCIdizzLkLUJNGgJ
BzTH6C8dTDReYPGbqfifuywK/1WUXF12Yr9bKzs06OA9QIDnqrHQsa8SprpcYnw0x48gL4xPvdKZ
n/MeaILfIKN86CUV0s7p3/I3TBTLlic0Q1AdrG3QnLxqNtEWCnKryj9qkxgPplqKz4OeODt5x609
MsOJiRGYsdVN2qHYS5wA5aDdALj9HE5diciHZj+D+1U+tEX8LS0Hdedcb2/v/9fchGet5QILrMss
UKmMfRjn6DNYgvJDWNXF830zvvUEU7WkZ+3Qw2P4dn2QFRA/oYI2CMJKOJM/6tCKXkTZ997B0cuo
98deaXainZtrMozoUcAB0L11IKFnMKI011kwlrTjfRMNGsXnhjM9lRneCQnGvWf/lp8goJTBFeqm
1rZGOylJLzJDz4IpAbcWFjW0X3oZiiddz+wPo5PEHUJRRX9UvGav+XbTfoioKKvIaNuQf/6fsDIe
QG8NOvajRM1LhUqRnU4Mddj9JyVBFGMu9uocNxNl+CL+b8WNgy5RGtPcKc2CUgc/C0mZemxrEZ4A
lDcvDsTfx8Upvxf6hHx2NyyXJO71HZd0K1WTQnNE94x94JvXm6ZmCxi2xqz0orQuCQz2vgs/2U65
8eZnlYNp76gEqo7rVfIlNpDWarMAnfHsbFHbR/zCdlGuHeKPA5D189DN6HgqyPc+3B6EcuM/S2++
qh3DTgy+iWYG3WHF9+w8/ipcMI++6kgQ8f1bevM4JeuAvDQACDZfNEraoTHbPA9mZYGX0B0GIqta
jNNedeOW4wEoJ5HyoBScbY9G7yjIa4lMzFwoV/3UtqYO8K9WUFBoVDDx9/d1czmicXpCkNUwGbP+
gLVeL0kauViqTccBxZJc/AYItv1XscM+/wmbJLeTrWnZqTE2YWM+pbFSLgqurs/rYwteH8HAKd6x
yZtbgvxJwnxpn2yH5JkMaKvIS/Kgo6ehongBNvZilHH3ZWwdt/2JDIpQkEl4Zpgg9tgEIUpLl9zr
mzzoKyP70pnd/L0xvPh3aFlM99BSQviJKhMJG9wQGoM/5KqbYCMstRJmiyUPLEdxiPGL+jJ4HVjE
HGj6oYpn8xcRtvPTw4YCdyXSDLIAj7jG5qZ3yF24RkmwZS4G+oIwzec0D8Gn+a7S6jv5xa0IF62w
92QcRiXGa9dmiccO7Uan+tPkJXMbqHG8JGaeP4u5nC921OjnTg+LjynIs9q3GlUcFSZVf8+1ttyx
JrmvTZAJrdQ7xyKjnOQh619it6GS40Ehrx/MqX7umxBEYVioYEWbZDF+7cqm/eP+Ud94r+AbkuV5
prowq82dRIgUt7KMxHTUWf/SqoiZlSZRT4U6GG+MfIVnAPDOsOMJbng4ypZyXpW7iZzh5sjbuIYE
HjrDwCyXWTk2sdOBkRx1Nzvd396t2hMeDpIsijySZmcTWzGE6ChV2SB43MxmdtIajwYcuk3516WD
N1tC+tOnFNXLdLDSE2FDcYxFxIQ1rCuvYd6KJ7uclF/u/6pb31l2zSxuMTHmduRqgTtckEEXAeAn
7dQh0Zr7CpzXFwZp1GeGUevv9xe8FSSg0iiLf2gHcZs3L7Qejt1QQEUcEAGFMFd33mGp9ZlJB3WU
UxUwG9IAhkS/BxWrcmK/qkpW7mz7lq3hKgk96cfwCGzeNfpLwIM8rjVl1eXXRCx/uko+Pynm4Hyp
weufMbc9igVpSdsrZaBNRbuZvVzpoExZbiojXefALYz5cx+p9vKhpnzfHDxqCtCs579ltKRmkD59
NPuT5xnLt/uHf+trEw5SymaukKb+xofWI4MlFhTcdKLmRvLslib6oKSHP5ymHLoP3tJb1c5Lceuo
EeXUpFAqafuWw6ppYPCHzD4PWiUfvurpojwXamq+OvNQI52kKk8x44Dn+xu9uSjlekrNNJ7hT1q7
r2myZqPpoiJw9KE6McClXNQ5Yc4Y1aQnBhe672OmdDtG9W662y8M8pFiJuUQRkY3pq3kXZh3ilUg
a55Uv1HsTQCMO+O3ZqnGC9TYELMn8wno/uIrZhgdbRidDrR06mdt6eKT21TmpaoZ3rt/GDc9DwyU
FPYJuSnhbDxPWCkJPlstgtJlhGBQOu8ILG9ENBJMwEHRmPtCmMT2h2SGfh3eVzoRs88EaHiAhLWh
/BunO+/qLUskLSGTJoSAiGbzk1CfqUc9FkVAm9lBG2tgFJXT6eUQYqI2vDLDXO6xqN66gbLtILNp
/r2tV2hdFYdwqxaBMtfa2WqE/ow2RPLMCL84TxaYAc9FXWsopjDymd2b9wzkllnC9kkVmGAQogn5
5/9JyfJkjMuSrnOA5BNsHWNPn84fDIMxAvDsywXFCesV4zoIJjzhsKHwbTN86eNUoN1ENOwlbZv5
X2QSqHFMjZQL7yK0hlV9zP+5bzTSVte2zK2TGY7sNkIZvnmNIQZqzDQEItrX6tgfmJbQvhp5Yy47
N/U6bGXSV/Yz8YwUObcdiCyd4FSRvbVOULWb+V+LR7DuqxctdxhXfHhXTAoCEpRmx2IbsxNL7zGu
YAPmzU07Qpi5EsvFjBIxPhxWcG4QSaEAKYPHLW4DiZgCLn+64mgXCObJqgJpkGiPgk4+U5uPhMak
ZI4FySs7k2t7UnSjZbeUF2iAVwnwL7d2j8BIkt4vEyP+VihlwQRdC1jFF6qXDX/eP87rC8VrBrmo
TG0Ij7f4DUSQEIFOkywAaeX84jG5tJxKfVCj32ulqalFMnr8N8olCU9L17XtaVSq+eFpdRhUqEFK
fCkMvTCZrg9BxHQkEmXMAieZ81OeofZJEz6pMm6MNoN4Ei6XReT69/ubv3ZhPGiADySImjuyDZ3g
pokqQhXSumbSwwN8aIgWTa1bzBerYPljPJj144hQFgXpapJz8dm3yIcSOshan/jijZkv/1AOXA7O
YA0XMzfERxLz5HfhDd7OZ76xU8DvNOhotEhSqk3YoKBuXfc9RU/bHD3qvITvcILkJWOXxuQljELl
qrsTNtzwCzIeJVLUeFJpT6+/ahrncZEtlFgWlXHsY18MTvaUC0MYvlso/a8Pf0vZ1JBoShyeuWXn
F1QDUJ0rSC7t0WBUuGS+CTEY5avbdmNAtb1TdhzEjf3RgYTj0LRwr4C71vurgFLYtRfmgaZ3qv28
dKoYTx3tl/obfA/Nw8+tpIMGKw5RB+XWbYd/MdPemnWjDIx8qY4qHAvBUDSMp1HKuph0Kb4+fJ5S
Co18Aqgc9enNQzdPblaiLsEkbGrnT0tnGH7h6fOP0m7b6dAxy7rnCq+fVjgWJRmIRHfpxNfr81Ty
WEuTpS8DBit05VhP4VsIcYeP8Ff+hNqW98HLUeLbsdIbryTlARwwFQkAOtteDLWKGPDsUgY4IP2r
wsDcX0LE8/P907y5CqxbEICCpL9iVdKayOxT4PlBNVXVKTba4eAq416YeOOWc3aM7nB+Eo63sUhY
W0thiqkCmkE+fDYT8Eb+mFipfl50N9bPrT5r2c41uF4U/CsTgVD0kJgwi7L+bEYcNUnfemUQd4n1
2YkX84sB6cCPJQ6tL3nV29bx0bNkQomMD5CohLlvx5TSUvLQqkYV9LatnPqa8fBw6JSdPsqtbUHb
StWdLh2cgRtrLCPTTGNkDYO+cJhM1HOmwIsqZPq2oVS86Mb5J3YlYRxAQGTAsfl26Rw6nQtLQGAr
o/EadwxjGtW88wxcXzH+flO+PuRVQM/V9bfqFIUuW5OJYMzL9KUM0UUPo2HgnS0Q8YOkZvo9jNxQ
2zGRa08pl6V0AhEukzHbXmsdgtWcDK8OIFAZ3lCm1BCaaiEEQPkhUx43D2BG8EQZoGGkrvZ6j0lP
DqdHsQgae/i7r4seWa3HeW5gkMTy5E2DOvDKOgSj4bM3jE2Q9qI0fErf4ve5pfJ3um8VN6yQ0Brx
CDigsIrtnNwclmaUU9AKdITB/aF2ohd0LP7V87oMJqXeg3pfL4cHpoaP0A3AGkSn1mc3VyakG9ky
BnEVfZ+E6xwUtf1kW4OLqtG8NwR4Hfu++/v3GIy68JbvreiQLIHbYgq0SrHBq4WIFYdq2mUnnm/v
YzkUsQeTlyjEaUSvca8Nf30ZcJaMT9Hb42GlorPerFsC7S8zMXPDIX4u3ea3Tlu+ReCpDsIa38pa
FecHvyaPGlBHiXOhwEBitl6xtxCKNaTKd4xY3rGZzJOiQ2sRly7v26I9GjG8r+Zw7UA5cL4bD6ap
LTNotaa8JrmuPpGgSXGkpFueePBtpCTwDzsrXt1zqWMABE4mgjrNps2JSunKKhdknFC5LfZxQje4
86NQd/5p1Hiydu7G1ZvKarzbMmlic8TS69OkCWuAopDTMwPCdubUK5/Mft4DHN7ak+TIh/ScC4Ew
7HqVaWwiAy+QBOO0QO/hIiHvFq7youTl+GiQwIbk6Bv3HRkIWk3rpfLYSks4ktNAVFP9ApInP83a
qO+00OVHWGWcrALNpsznCHyuRlTx9sgzwsUU9JRXfq0AjMLjmqQUE7siCsu/xjLJ1By1ykiLPvRG
iAA9cpe6t8dsd+tgiWNpdnF80PRtDjZW1DBCOQncoOmF1anXRdUeoXmwhtfUs/ufMBbgmcSz+FHK
ivLX/Kdu47WD1TtIEQZuCdBaV9UqOXZV2XU7r8+tXfEiSAAdkRgtifU6YzMXMzgbADW5ky5SiNb9
J3H15aCFMNf81GJgRyjAkdpt8dMhUmdMdLAYINCBqoGXRifYAprPS1HMD/PUvu+KRxWgnvTWm9hh
hGmns0eF7mQhPGatrKZLIIcw0r8ZGk/edLtIH74PnCMPEczh1Ca0bUhU1JCZULkqAvoIckJndErl
3BUV7FyP+mWwJPgsxjtweoyxrD/akJZhbDVUFZu8GwQsMhqavRAqVfPRGeok8oWQFYj7i149P5wn
1g94lRSSbW7s317IHxNRREFUmUqQqIp6VmC/gpOlKZ6Wuv2ut7GxE/9dve+050jGpYOhhnzVwEpp
XqQJmNzATKfk1DW1+b3yxPgZn56i1w4n484mr6+DyedjFJBWKNhkYxNQIC3tTdNI6yCbqEocvcpp
/1bUaP61UVCUvdw/0evd0aWgN+ICqgOY7myeH1GhK2mDaAuKSVGqg643an0c61kRsOM4MWRRViH2
VDGuPyPEAmBVJACbDGhLbZF6Zm7bRZcHHpLILzArQ96Vz2b3WSew87t0iqAp6xNtx4vf2CsoSrCD
hE10uraMsnYJhG1x6PohpPijM+Lk37ws+2+uWQoAnLSdv9w/282HpK9KGgQTokTOMqW9vYsLCMJW
0avpFT8UHjTZ83JhIzrGnbPHTi1v238eKLkUtqLT8gEq6jCVsr6NKoAjtXbt+bVEIv1Lk1Q2Vcgl
2YlVbq1C8wJBJn4xJarN9esWuJXKbp5eVbOlxoDPPqWmsasMKr3iZjPyqlFZBc/BAOXm3bFCFJOr
2Jpf5QxMdjC0VOin0mugP0wEVnz0htaZDo5w5n+jDgF1H3iI/TEioTKCES7D71pUOZ8rtRPTqS0L
Q4cdLQ+hUUranOOHwEnxI1BUiDUVQEifRxVarhezSpXutR2w3UM1It59pmNrjhd9Nqr4rOZhYb/1
zSiGo27G3g/PKRC4F+FIuuTPphNFH1PbaePXrHbb8uTVczMeIrVROSmThOdJBaoyP5eeKL5mWews
ftjUxnS+b3MbG5eGIOHvRMpUhSC233yiRddqiI1c9VX0Zfsc5rV30oocfjIvFTCRCf2xIRq5HoVm
IDG0MciPt5UMrcgUUylG7dUYhXnQjNo6SUCg3y9GuuOqblifq+mECLynNFa3YQLV/MGew0V7VbOu
8/sIpMDSRnvvmjygjfEhfCtZbzFBCFk3B2g6MLplzWS8IvehwErYTOF5dFrtFGmZctDn/t8u1ezq
PA+Mnd3/drc2yIwQQYkD4OeqVW4o44DwYz69CqssjiVC359UPXd2LGTjfPlilALBKVHsooFA+W7t
KrgIqj1BFvIKO9WvdgLx1OSqvijjHxFULP4c7mUD19sydW4ebTUJOqDtuV5QKfvRbkpFe02h2ntq
0/LrbNZ7Y2Q3F3knwaCwIAOu9SJe1fZdagv9NeqAvfeRFp/xF8vx/he69ujUkxHKhkr3XSF5E891
ed0ZCv3mV4ADYXUe6qW1fADJ1JRhcN2dwLvxqSg8MUgOYy9g1u2mHKcT4RwO5usUe9r3Hra/Z4NR
8he6/NGrYJz9PGVzuvNK3tgjGFKWZdwDYNKW4kqxtHaG3M58JZFU/jHdJvy6jAlDUWiNiMfwVtgi
QGhuG0qiNCbNbWvaGmctaVLXfIVYCz5wxcqOZh0zkQVt3jGkkbVzw669I+vJppXkH6CWIK3oPxlN
VthjFFLEeE3DbDxOoVUcnKmFd7Eaeh86xunTfXu5/oAyVn3XyaBdR7NuvV5SJQzbwS/xSpTqDIdw
Nuru2VHcsnnWvNYRH1pmWwC450Vm7USR137MMmhIMQdggqanmLFeulMJvsZFs14TaDwP4aSGfwEe
BmAEtugyNdH82WQC8DBpwx7x1o1DlkhM4KxkzUxWGuuVU7rA0ezCr0MPcjzWadhBwjiHPghN1y/L
yX74o1JpwFNbFO/l67Dp0zHELGqGR6kQOVHpM3adXbIliQ9GkmeDL4Z5+Pf+V732NawHTzjJI6BT
gvT1Bmdvic086ZRXTt/0u66ES8MVeyX7LSySy8EyjB3JjdEruOL2mRYzczJbebUUKyjNbDm2A9Lv
lvqv1RmR7ybdlyR226Ojzm+jZj256TTtGNGm7vG/P4FxDy4pu8XvrXcK1hqQJJFN0Jt2Hx/tCdHd
L1nFHYNu0XM7OFSZxS8u8GHH4Y9e02BadFQICHf87vU9Iu+ieUE2RMJJ53n9OxZTF3GWZFHgidDz
56avNXrbbf2nXTO0WqdM+5nxJPYKE9fbJ4WWaRHVPdKVLQvM4HgTzcUiCSp7tp8A1LfzyayLWvXb
WLdnGCFV+09Dny3Lrxej+1pqwvzxqK1R/qcYacjmDY/15ho7TqM6yQikK4aY6bXNtPRklWLcsejr
K0v9RZbLkSfC4La4pHRywiwHYxuUiq76Yzq+0G9xfW9QXui972Xx1/eH1agpASGwTXKJzYXFWXUi
jboiQH6m/J4ZpXlyvXR8un9yWzltjFcuw+FBLMec97ZWHcO/bS66UgVJ6i627gtOL/ObhmLipe+1
5EdVmioqrOVYQ9mpQCQ+vkSwSIxHt4Th0a7VwTnYBUpDX6BG8/6J6CxovuYB2T2krSqq46x5kfGM
x3HSnXmHW0dEhZbXl1K7LLevDb5Ie6cqe68IUq23DzTMlYNTwYp7/4iun3pAQVJ1kCEdMLpXBb4J
VZfZC8vAUXQTDUzXPo5hbh9qoMPn+0tdbYhqOognoK+EnKR2m/isDxe7Lp2wCjoN8fpxiJWDC7nq
TgPyyk+wCncFmyIHome28VdVmPallo81F7ZIzqIxCCWa2Vb8MESgxgdAPpx7W493TO3G5iQHBPES
I85sc2PQhjHmNuwfqEzb3XJolZ5JVVObTg8fIfkV+TBastQTt8XEvJiSbEY4IBhDbTh0bReRdtbJ
8f4qVzYBsZv0snTPeE/RGllbHozoViKSkb1Am/u0zHb6mhPaHKnJ7DXqrpeCVOg91mS2lVGxzbFN
C/Ipg7fUwTK29qXtTec4RDajfkr88ANCAMS4BiMN1NUkamy9KyoxmQEjrgh6bdJ/49tkMIcg03dK
xTwlvhj7EKqYRX80vpXLonmF9uE7+m6zQ7VLSz2uGxGkusEQWjenUJ+Hy/cwi4uzV+TKgxM+TEKy
II1+QmlyLQKI9T6TTshKRCkC1c3rJxdk8yXOsu7UZ86DrbL3pThMiZeky0o9b73UZGm9mTcaSyVa
/aSm0Fu2idmfMmpDH1LoTz/dN8zrSwYPCcEQlTsyPCRT1uuZTp16SmiIAEivfaoKqzwXmvIgMPN/
d0WFkCsATJ4SynoVS/Rmkg+eCKDtVI+RqxV+PtrL2dLneiduvbkhypC0lpB8ZQBsvZSjZfbYoVAf
LJYW/gk6afyl7eZlx8dfu0SO7T+rbD4TbSL0Boq6CRitsA6J7XTTwUj1Bi0JsKD/KNb4d28P6def
+FgwuUtfxSfbJnbCKS2NYegmWCI3ehklS7mBCMTjJ4i5A/wgj4SXYCt5bJldqMSN3QQ9dLhc5RQJ
kjiZH/aIRCQSDizpuhjV27zFIQT2onEx9DZMs4MJ5Wrgimh6caD0/+X+sd3wiKhu03SSs7o8ERsb
B+wXMey1iCAavOhL3izq86zFH6I5GXaerJsrUVMAQirxqttSbkLZzio7R8B4qfZHt4UXUotT9zAn
VP7vb+qGnUsdKfwuCBMJeV7bOWFMZwxF2gTdFCmHotbLsx4Zn39iESqRsppAx3IbwRaq3aPhWTaB
JjP7rlhGv5u1vct0FSe/WwKhr5ywoAi58efNADd93Q8YHDf1WdRw44sZ2Q+CNfEcFeWeUvOtr6RL
cImMYqUU5PronISqltfP7CoJp5Q4cO6Vc6kk3Vs/WFW/YxO3PhRoOxBckniDgt16NYPxzLCYl4aR
aaO+JJGKUK+FXs79L3V7T/+3yhZPFXqMc8FL2gRtkjRHyvzlQaTouVRx9OP+Srf2QweBIIbAzKBv
vt4Pc3vdQmGyCRolGZ7TcTEPUTuFp59YhQxRZhvM3GyjmEgvK8j7vCaooYM7Ntr8t1agxPATi0iC
GbohROzbSD1pxKhEY9YGoR6bx2jsxks8W48H6QTPvHx8HFB1V3hZ2Ppcr3erNgBk4P6hGYPlPZuI
W+qXn9gNQ6NyLoy3fJvUIt/U2UtYtLCrIsDre9mk2n5TlmKPbvSmBQBFfZ/DohkibfE/9b7OszqG
oBKOrZjnI6mB4yPq9XA+i88m2ZSTqxBK8eatV8l7a0oGEzo29KGMU1i3CC45wBcePjRyNElEA30T
2H99s8oAnthqbEjf8kE7pGmiHI26f9zDEYyAwZAKzPLfm1WiIbWR3bRA2iPf8IueJOrfTI8Zn6Kl
y54nnNCf93cl46lVu4WyEvuhz0e5i6r65nF1y6FyJhcA8+LUav9UxZ1Qvozx3C+v4ThX4rWcwtA+
Jw7K1k+0iLvo4RCdyiGVYPjASEGAG6+PdSw48skc6iBrWkq0cRRpP+ocJcYDE1XK75Dy9Hse8PoV
IethRckxjM1sAwrTS9GXmk2uGRFMfyhLxSzOIAyWi2EhIOI7elHslYOv15RcURLoTOWGSGlzE9Se
4coUaFkQzeoYHz01F/Zv+WIM0VfFbBTjzzpLo50ihvw71992vab8Tf+5fVE7DhM13y7oelX/qCFj
f7SoJ/4xZ8Sg983o+qJLd4Krp+OuQXS3+Yquu7SmAi9iwJSTcpwakMe5iOqdB/LWIWKq8J9TK6Pm
s9lQMmjdoLaiD2Yj+1aYbe8jO/WxX/TnPq32gttbpycVYulxM7KLouL69KpKWzJKun2AOFv7AgnX
X6CB54u7IOh9//CuVpLeC4sGt09biydmvZJiUPmru6kL3KpWjikMmwzxGK2fLHOzs9TVd8Jv8SKD
MDYJZ67mFYpZVImNNnIQljBlZanXH9Ou3rtgNzZEFAhoGgCURBxvHHIrpkFLEAODLSQRuh91yT9T
FhYIhVvIdj98eFTHbQAL3GUanRubMFGZFqOrD8CD7IrJ7pr5TmSDPK0+CNQe97Z25S/fUeg6fkrm
wZSG19+KuMlq2sIcA90deQZ64HnlAYUJu3lCwcuibTy3aE/Rqhu+CVK+ficQuT5aAlHJYMk7RLHr
Cm85o3jBJ1YDO8+T00Cp5dBqYX8ZF2uPo+Aqc6VCjGEy3Mbdpu+6CbaBHS2xGAsDZCzCnOi3VWQn
bnpGztgM9Lxx/sqNMHm0+0nDDN/MmyTpkkmd1+frRpOgk9s4Qe8yT3ChAxRZF3jMNaRvB2XeYyu6
vg9UXaEsxnboltEDXS83jf2QRV3lMhA8qIcu1mxf1Xe94/VHgzmN+IQWK5hRwtT1KooBJ5hnpEuQ
x4xjHxu3wzqdrnVL1BIh29q55PJ6rfw+ZKr0rWjGAcOXuOb1crWWSlGD2QiQ7zaPcQXkyZ7d5qxb
k4oSs9APbZ/QT6YI/NQKfe8tuLIbZtreOadpBuJltpQwdgyGo+idJYAYrYnO7tiwRGu0Xf6BNldj
IcaJiuNxidFoOd93Ble3k6UBjYBNofZMGmWsd25qMZqUYaXB7O3W9TkdjFg7e3Uc6ydu6jAdeXYt
92DFU76caqU1HySokYgpk5FYCiJ8aYgHNgmjsImiKm0wg3RBsc3KPPcXLSaWisdW+4J+6V6T5epT
AzsDk0OuwD90QjeetusLL1kW22KuSGmedCXM7GersnLalLyRp6xMELsbhQM0wux01MJMMmXjdP/U
ry6R/BFSiFtOODmExutTV0BJFHOeWRQYIKvBJeUvS2npO72Fq0sEbB7KZfIVaqw6gMn1KkVbL+7g
Qig2xlr1Ms5Odqyp+x97a1e6/eZSst0K3Bwn620uEJ0SkhbNDQPL68z53KG7Uhwi5PqWg9nDoeo/
en7Q8FKl5h/CYErI6505hnCKaeicYPLqyLcj6IlFktQ7Sd9V8CQJ4Uj2wHxSRbmik651j2ZT5jrB
QJ3uzXEb/W8HIMtzPaLn7RWlukOsc32IGAXZMrhLDpIPt95VPijG0vWuF8SzmzG6AYXAgYZu/smG
quxRj8frRNFdduvl/PtWv6PRrRxpzDYMmD8vYSZX5uao1E19UlvTQmITWVygkopb6CdNie0cwnhz
2TnfG/ul+UTHU1Kly+bNer9pbbn0UzCaCp70p0rr+2NSVO5pcPr5032DeZ+3Xnl4g+iXmjWvM21n
0MrrtWwjlxMKY/bWhJro/BjN4PqS8uGNt0wVfXOyExzuEQlCdEYaIoXurDZNY17qYZ6VJzxibh5t
K2qZXhilpmZqxOn8FV6UsjkraTKGvl52dvahWYxmALfpWf82rbAqv0IzYUZ8NS+GwbdFDXFznHlG
/62ZE5NVIBFvjmmf991xztMKUqOZ22T6WdQwishkVBn+mplmOD6pWeVGfoNDUfxRs9vLTIE6PEDF
YxqXzOymN60AvP8p9OwwfE574HIftVERzasWiaY5tl4NB8VUJqbxXOpWlaLMaXYFALrcLH5jJmxe
zo3ZhNNhTpep+LV3GGi9NJEaRadU79rlqFrkRb6b29OfcKKU6UE1uBCnpCgg1atThl1PbhFNrj+6
iyE+Za0+II3c2JbyBBNvOBy4Z2N05lxV87RkUNx86ktad62vzfPondXEaZvf4j6D6trPycYMaDeE
6My3RhnF957vNXxNh8Yt/pj0vi9+UZKGOnBUR1n46yRQFUOIPZzi8MU1krL/JZx0df7sGVU7g0lJ
tOh5GRut9msoneoLACeL+JfI0/4EcNatnu4b3bX/oLZLLQ/cNo1JYpm1zYE9bVHXK7I3wk3jj1GI
5VtsIExg1G5xVtS63IkEr99yslcaXOgU0puBN3O9XjlpC+RFQ/1Wjbn1QePFHo4hlOC/UXyOX0Y6
ta9Ar4Yf7aRNO4nzraVlRZGnSkJQtwlZlkcFuqCmeCsZSBue6jKHU5KZ/AXNjtlwqsvM3H73MmrT
4l0WCt87oN7rCIrmFykhkt/8BAYu1lsPDbOdB0W+P3auH1Enqn5tVAh1T2WvIJVjtqVnUfNOh9/v
f+Lrh5zSPccNSxama2xn4aB1SBq0i9I3RaQjUsbzaPqxK+xyJ4m5NiUaHzCwwjpPI5EO9Hp/ospM
tedRfRuzDh8wVHr+b86M7zcuJzCnJtes+nR/a9femSXZEdujsgp4fr2kEeuIsgkje1OypdLPOhLp
+alkynf4CNXD4j7dX+76JMnCYHmU3GYSTrx5/JKKGpKrwndQwEh9yodZO4fFo2PsRJvAEADxyIiX
//A2V7KcxmhhgDEMMsPsLjXQzc9VvwxPKjR2pwyIRv9wpMKCfDBJAiIbFZvwVjdTM0XoJQyYhNMv
XookBQJPD+oqym0xIQmIhMf0nU1r/a0KKmSlbSfpm8ctfzOW2D44SuQ8/IlcOqM82CSadFu2KpGD
kxAwVUb9FiMMcWqRkvRrPWp37O7aEGDbYGKX2ia2QKq52YvVFnXe5+MbhcX+U12YwymN9b2u+Y1V
5CaogwD3A3Il//w/lb480heqBvb4Zurl/AI/dOgXFGYePjEk82S+TGLzjutarxJmFPFtK5/e3uGd
olCSH1NdL3ucGtdXlZoDd5WQERuD4nu9TAlkjImgYXpLm/JDHCrOIeuiFLkZhmru39J3xcR1HCWh
3WTkpC6gg7fVnNq2JjxiOr/lFWMsIPGj+LOwZ0SonXz5H+bObEduJMnar1Ko62EN92Uw3cBPxpKL
MhlK7bohJFUW933n0/+fZ1d1KxjREZMXAwzQF12QlJ5OOs3Njp1zTC02gzou9qFqw0bekn8Y9WFK
zU5xR6Qq47cwl8DP6nEpQjcxesneMul+fGOMoWT8vjCDJr9ymM48GaExIudDasvvu4oqkpWFClnP
7JMACSQyk28mpet92yKbufxozpwonNmJl4LMJRoRxy8h1OShXxC8+YgwrMYNQt0qtpI5Nu3u8kLn
9kSiQ1WH2w6xeVX8aEHajKmRLP6Q9sMd+sHcm4EVN/ZiKVce35k9ORSPQsaOIw3EmeM9BU0qhXqX
5r48y8pNFy6RF6ZZeuXJnV7eXNyELkziAUCpuI5XsWJZW6Rwyv2+HvobNdGrj0gYja0EHOg6GD9u
sr6fr3RRzm0N5rVwF8fZ56RiFebp4eR0LFqhWa/iIvdUoNFr38uZlwUBAyALjxHu0HWCEDZDn0hJ
UfhxBYrg0L/YQ0EqvFHW0oM+L9XXHs187qIVG/dBM95Nsj5+1ZMwu8sYaXhP07zZhiXsNlPPrxlB
nDwDMErhQyyoImjwXvwIfwqCuBDP6mz1ij/kBdiAYbeuLFnq7eXzerqKQM5hhELqAapcfxg049CV
hcysjWaoukucKlsbuv2Vo7o2deSLI9SS/QkZkiCgrk5RQqlbpmrXP2ZqPpuuo5MQPuOG0LdvwsWo
5Yeip5K9oRM9o8RbLLvaZ5K92Hd1WISqF/RJ0m0ZWr5M7mSOA6jJMufXPNBOjoMwICLd5pSDNUL6
PD7qpkJvsG+a/lGV1JqR9xr0OvxvXElN1StH7/SxC3UByBqUfyDiNUYCeYC6C2H1Iw2UxhusqNxr
SepsXvtyxSfLCmIR4ftyvKEMX15GfNfD46S3UEscNdoDmuavzaKE5FfQcSAYgxKu5/jKetoqUOjl
x0UylbtySPON3M/SlSN0kmS/rIIIBHiQQY5rCnONlA16fMMq1A5unxjfe225KWtmtJhBeG226elR
ALviINCWEL25NTpnjAk1Z6YpQNxOELtaigrEaOsQgDvTPl1+S2fXEi1yMcKJCSCrb6MMWpSbOEM+
SkWCEXcT6V4pcW84Jjjv5aVOjx3bEtNnMPiCvbrO4xktl/X4FSiPYxeaniKHwSZe6mvN4ZMrg1cF
5RfdMGYdBPHVZbuk2dipCw+P8WvlZuyLGViml951GoqdRiurnWLG17RfZ7cGYCuLAuy0yJxMO2pB
DJXHZZ7bnVYABUZpfw2ZO7sKmQTSEWjN3PPHX5TSd2EblbryGGlm7vVtUd9rfXhtBsT5VWDO4OMt
tBorGNzspnmqoXEyAqozvCBJ6ltJaq8Jq86ugrybKIRu4oRUmRoRbpazzblrLKzuE+Jy3UnXGCBn
DwOyLaF4oVJdcxDzOS3MAVDikYFLi6fmsW/Kwfus1N4nZfUwFMHrplpy03D4/rXeGr2P5MRglAxv
KKm6r0XIVJDeCauNUfTXSOAnzQqxEvUWrW4ApJMpNi1Ow70+S8qjNjK3clDtmzgsbqwIZw6tXj7U
S/k16IO3jEZ4paXDyx55mghgKctpZoo3+1Nq0GaN0SUx5wNz8GCv9sMMtdgpbjKgpdfms2xSsKrg
1FBVgHsfL5V2HItl4ZBEvaN6zJS23dLRACHH7lr5cu48EnDhf3ONkJGs4qAMztzSpVWZgOkwwM/J
pTsT8fT+cgg8F21NEDjBfgP1WzOS4knvjbmp1ccmsOwtE2ueA1gRGztMr/XW17PHeE0QgcCzaefC
JKFXcfzs0HC0VdCXy2OhpRFWnxOUo7lSvay0iv3I5Ae/X6LpoR+UYVcpXbAD5qxuii4cQT+ta6ZD
p48Xbjh5JP4YZGNos45/m7zQZkNf9OVxMsLZKzIHX+ql0F6d2FB/Qr0SVB3atmtzZlo+TYgjp/pY
8Fg3YTd8Nab6mivB6VYIi5xHXHDoG5wYRtLpTQFvtfkxlCppp4QDI8PsTr9yUk4yDrxEoGDQ5RY6
cy7n4wcWBFGvRE5kPca1+Wa2jYcBBacb4XRF1/naYTnZkkGTBQdnhJFQgWBiHC/mTDhvDklrPOI+
pW/GXGdCTK5dc6c8twpqSsEspKnDOzpeBb7vkDjTYDwajVG7pjo4Oz3tr8miz64CGIpcFRYCxI7j
VWy7gYODPOARdXuMVljSGAYfBu8uf8hnVhGWFOKSxA2APtnxKhVsC31BG/oYauWyYWa6sh06adpc
XuUkXNCJQwKDo62gaZ+k0NPsdO0kJTZmUm33rs5oFsVa2v3ADqW/8umcWwqzJXSZvB7BzDzekB3j
fdzwizzm/VC45aIOe0untxg7SfPa5jO7gsckhoWSE1H9Hi8FHJlh7ZTTYJTSaMOoUixHZKy823y5
xgY785qYDSTEoLTVOXarpeKy7HKppZcZysxG7QOlf1Dsbn7trS82hGgIbJpChwbt8YaaCJgv1mI2
5OhfYiYo32q9g9uAPb0WNBR+DRCSmLZGromvwfFCRYd9Sxzmoa9JSr+1K/VHiX/blYoK/R0/5gjJ
oxIAAKd2A8Y7FV7JBbmUavb249g0c7mpVDs81Ix0m7yeFpkOu1ktLZ/LtM420ZyO4cd4Lif7rcU4
RfUuBMEfP2WxnBbbuajxITNJHyuP3qL6WDXpEHxSxrFa3Ejr6HuWijQYrpoMpnZbGZLduHjqo1Bx
O7OdmC2MPW+xZ0Zo2m5yZ54zt7TlUNqojJOZvNQkI94FXdaarqImo74t5WnUdrkzdvXOUdox34cM
Epzu+sE2671jBfkuxt/Lml3aFpP6NOflMn6G40Zf1awn+y5MI72+wa/UiW5HJy3/yPgGn0lgNWW3
jIkdvnGKSI93wou979xJX+R4M1bQWJ6mibz9bZDqUbSfR6UBo5HiuXmjjrbBZADAWCaqKkU2uVob
OF/LvOfAk6A6Mkp/hiW4cVnkDLaH9+lNla6mbomvbvGGq3xqdrWeLE9y1lpfUmXMSn7brIo20yLp
X20d8GBrz8WivjMHzehuYmbHqh6KL0l1MYWo8QG2gspUtybEher3Nu/TtxBEFAX3D1KvXdEZTJXN
G4ZN+YmC8djd3FTjuJ9aJhPt0gQ1+E1AdYjvA05lw9sxVoYvEuAuFBnuQiPznEgK9Gfgx1D2zGXK
5j+YaWapXsLUjs4rprxqvcxMAutpIcVydvWgV4NX5MMy7A2lMJKbzrQmVPh5OY/SA1ciMka90cND
ySOKvzvWGKRbGdQs2tV2qn2OjELXPDR9WbV1xjS33srpnCHyHoLoKRwlJ/Mqs60k3Jbkut4MVjLK
HIx+UDfjFEWM3USyrd+n6ZAqd/kYzDGF4uwkhw5x8nyjN0W6uLwMie57a9W2l6Prnz16/En0xzKH
ne05YZP/CMK2eDJDBnS5BrlW61XhmDz1szbJ77Ol1x5mecoYEsxJUxwMwkw58ebCkMoNk0fL5bbr
5LzD4R+A5K2x6Fmy6SJdin1Fz6Rkn1BbhnvIIWa0XaTSVrdz1PWQMcRr+FRXSqvuAAhUw5OTZKx2
U5lU8h5qSK96SmpFtUuf25n29F6T2Y3ibPmKq545iOkYfE+uXgd6tomxl/k6KAz22bRQISoXrf6k
bmytVoxNxfR0Y9t0rWw+K0qdy16kNWoKLcNRD7Umx+ZBkcu2TF2EWO3nlO9W8UwjDVVIY5nS7cpW
l39cvhlPAzvhBYIYHV1Ecyf4ZF+HMeCqQgN9LJ4YjBp9kDCpfHrlItzigOgKAJNFt2nNhKGt28dD
uhT+INPBbVpMyS1VGr3Lq5zcvCaIkjCQR6EMRXQNWCijPI6ZVDZ+CIS165wqvjFiSf3YdLjfXl7q
5KmJZIVpD3CXSJOpH4/vD4Z0GJHato1vVJ15Ew1j7mmDom0ur3KSuopVRGsLeTc3yLqBVnTov5gV
3fg1ddAdRPYGoSFVDozzHR7hv19e7XRPcJXAMHly5ONkfMd7qiUnkLMx6X2nHGdsyMzSlUO53r5y
FfqO9FGRZ1KOCjro8So4GAS0OIbOT53BNjb5OMr3xuRMr5z6jRgKUTfIOwcPhggw8PE6aqtNc4Vk
DSdKVJlVGg25C9cy+UBvRN9OEIt2odkX4ZVXJorB4xuf1h0+QjAfxSSftXAki6Mp6EaqjdoaglvL
+p4oIwPEwhYtb1rQ3I8601WbXnq13AiqI6py+uD4FGMrtNpvKOP+tFSm+VhUyrTXxcQ0LJTeXX55
p7sj06TYfik7DAiPxw+10RYtF+Zjj5odSDtT0rX7hLbixqhsfZel6n0W40HjtKP26nyNHJdyF2tL
kh5yt+OFtb7mttQ653GseX4h5LH7lnloV/Lpk+8NYzdABaoQMQHuZNAfdVVdj6bkPDZ9kLx1UivZ
KXolfeoiOvDYHSwfLj/O036KQDoxgEVwKzxP1sRcdJRWHxK2/FnKi9FVpIJZU3UVoi8PEkXt3dTW
7Gjbpnmf/644szBWTaUAJl06lu2bIkvLaZfV6MUfUiszepfh58G1Lt5pWOWXBEbnZhQMq7U0U6n4
wVHgjD7RVyZraZJNQirsRv10bcTqmaUo8Ogukf0Th9Zt1zDk7UaT3Pu5MQ8b7OjSD5hlavdVKfVX
epNnlwJhhqxIxxCF//GJkqJ6dsZI7/0mDifLIygA6Rhh2JMryk1t7q68avH9HQUGQBTRnBMzVSg+
dPH7/AT2zVXWyepsjX7HW8x9FJsSk6SWzMAI0mYKmtf2/LPbwmgs1S21Qa4/2DrjbSE1VomFU7YS
hzcMD6djMipRfA2LOalU+PXgahMzOYZiMuvxr2ePUtdBxx98S1JiTxsT8lbaaG9i1aHlZNSoMifp
WofhzI0DIIn4B6U5wJoqfqmfnkmkYe4x03j1CaZ95DIcxjgEPJMrz/70VYt7jRMl1IunFfmcYbeZ
5svkqz0tYU+TysVnYqkTb/p50cMrqcGZ1f4hdrEEy/gELpzzeFHAzhYfXeR8E8c93NUgjt8gAfp+
+UydvjMhkARmFdUyXlSraOyUzIDN52Dyubmlt1g0hsYtmLm6KXJby3e4wNSzl6VjE3mvXphmOygy
oevFxvb4vWVWCNMEgqoP/FBtgNQlN1KkcdPLTukrdZ3djCKfv7zoSXBmIIpIugDLxU1niT//6bBY
Cy7Z5RDOfpHNzlM8LOF9IRkOLn3x8KbNU8zXLy945kUCTlKgEyIYibo2TVX0vqUyLFiQh/8QWglW
Jph0fwiCLt5fXur0Q+ByA6fkRYL1O+s+pVkEirZY+ey3sh3dq0mK+WAeXxsqcO4JcnsiE8bE9BRq
K3UtVKjOZl8PovmjZcTtJlSMbC/3SbDpsay+Qhg9syvhGIksgiYi5KnVG2udhjmYcSH7KWTUd8S1
3A2tuP746mfHPEeMbYS3uSDpHZ8LAKK5COZa9rM+x3dPi6ud06nXPNvP7EVQ6EEpaRcSJtcJSJ5l
UYH5tG+MnX6bjs78AIxzzdnh3CoEYbA8kENqsdUTG4u2pTPdKH5rQZRIs25CSzrlm8tP7GVe2PFd
xA4AdrF8JebTNzx+ZKMVh5JtBbI/0C7UNkGlQZcrwVywDSwn+bs02ZDYO3i+b+cmqp0dZP82DAGM
Ksm5mRtZTT01cKaPszXNyzd1LDJrW8hWb3gM0Rxtv1ELOfNkE1LhXRo0zQ8riM3urqzjwf5AGVrJ
uInFNCk1I4qS3RwN0iuHqFOZ0bgQw4zhz/E416SJDj+2bChqxdfz2HqkrMFjP61iwUNUlE+XH6h4
XqvnKeSNfL2UhAB6q8MxNTnxI5EVCHsySm3FgIfqoqbTDmDETbttskQ1r+Sqp0eF65CvCiBMTGpb
N0jtDsOyaSqYriKl6l61YyhMi95eOSriNz/eGUA2wmkeoxDoqqudpaoyFCm2DL5jlsP3zGiHHQdX
eyoWIK15asxPOtOvb5VZ1q+w3U+jLwUc1FFqbJwnuPmPz2gfaLCFIs4othnVm6yZlY99Cqd/nMEv
L7++M4+SpWgBA08geFoTGLlrOqktWSrQsvFB46jcxWpv3V5e5fS2JhkAlEBDSgDB+et4Q1aHSzXD
0jUfzLfZFMZo7PKpsB8mtQnfpbGZ/e4wYX13edHTreHBjY8arFW0npB9jxfFWzlrykLVfBowjmc2
afzRdiLj1bm0IEHxljCBp4O+niM2V4k+lwxY8hl9GL9hfi2fuj2aD2ZtXWP7nh4LEBdopgRJ8mn+
//GG8slyKon+p+/I0fdmcbpbua/m3Ri111p5Z6Ik/nNQpGlNYVBIwDxeKjLBlvVaM3wI4anE5F8k
fck2TbB6ulV0piJuYn2s0Bsxeki5M6NlaTe1WZe+7NR2s1XjqZo/xfHk4E066KK5NelychNaQ3yo
5zScN3Mj1b8zGTmM31pQRMIbFVONfGsWchwhSrIZi6z0eey40FXqAMFT1s7XshzxwI6/cD5wlHe4
wnEGwJmOd4kjexGMdqn5TRv/UXa15ll6f1sFSH7UuP02D9HtnDZM/pKuZK9njqbQ7VBrk40ILtjx
wmbWLiOAt+prTmm+WXRJ+pYZjXLlA3ih4K32R5OdSwAXFtZZI3UDHizNYjeGjwjK9oD+jcfMNvtN
mHTdW8VqW1/Gt3c/G33pTfNYHRg0EG9Ks7s2Te305Irhvtzp5JN0IhURH37KX6nf+hjjAdu3GDTh
AlRKXjPVJcD9km5f+9ULrZ/4GLkAhb/W8VKdWYZ5QBvN1yU73mqMs6AhQlfk8ipnNgSbGN4KCJtg
l4iK96cNzaHc2ZGZG5QfUectWSG7ZR7LNJpM50rBcXoNWaKBT84qgMOTVjR2bqnTV63hK6Elbeaw
7z6YSjp4YWMDeih2hAZwUuZkM2lZdUXxdXpOWRt8nMDNaQWRPd6mkzekfPjd+pVUJhsGlYZ7e5zn
K6/s7MNkggFSW9Bw3KmPV7GRUDGHYjD8sYLSl3RW4PdmUu/q0kmuROvTL54NWYIDLoYzQBo7Xqpu
pInBo7Lhz7AxcQvljnhy4rz9FHFsN6mm5b9nTdJ/DoACQzcMTeeaZ+m5zYoxtgy7pONwcl/osR4N
VSXxSNE2vJukaHjAXTH8xGG6Bumd+f65crHng2UCCftkOknZ6JhTBKrpY+EzWDfBMkiWm9amgx7S
ShLLK51o/Fi2cZOTvE7ZsJedNq4fzEaxl00NF6u4Uuyde/4kzNxiFO/kqasDpaezhednY/p62M5A
7FlOx3V+X7X1Vi9Nw20D5XvrhDulzF5t7QtNHqUkjBEFBApS/vGrXxhyMoqZND6ps+0NsRxARg+b
fdx0/ZVdnnvHwmmFO5THjwDgeKmWngkoamT5QzGpLnQm05c6E1eSNNCfLgeiU4YW28KqhgNFBgLQ
s1qrG5lcXoejxXnqBmnTL8P4nGQ1voy5lC9vR6WdZ9da+syfxzSeNuhqg3TXlV3/1Ca5Oe21VI2u
gSRn4gZnm8QLAAH0cE2hGoqwa+sysv1RbvTHcsiHhwki2fvLez+zCjUOlo04oIpxTas3asZhhXyk
d3xr7CfoJkVbfh0Mc359rBcSBqRPVNm8rBXjyCwjq1+k3OZGyVMYR/P8NBrKuFMiU7+yI5FwHF/Y
QEpUpnD7hFP3GhS0En2x+kG2/czuhg+DEQX3MOvo3FqZ7Mp60H989RPEugYmMMoRGp36KvIWUlmr
wFm2b1pB5lZdhpbX7q6NDT/zOdD45HsXxprcy6sH2A+tFjp26vhpXvTbwO57TymtHAteubmS8pw5
Ei8aNfhAwkxs7bKK+LKHp5U5vpkpw2bQaTUFQ1xcuZLPrQJUjFIR00vi6iqKhbLUSGggOXipWXtG
HDueJuv9q6tc6jE+I9IYrkYy8eMoMilRQf6Rhoel6o19UY69K2vBNV3Lmb3Ao+IUcN6IH+vUzMRB
GGMNTKCqUcu8PrbS25QIeQUOexnMcnSy+U5fbH3pGJOcrceI2smoWDmDZw96bvfLZiZoLR+UtC0y
l8medXAbWGYzbfSgMH4MubKYh9HIZRTPpVpUb7EtV6cnJktCuyDDajKP3JwR1cJXQkpcgyj3JZZx
WXFrBr06G+Y7Ofz/tC+kmywAq3qw7bGEyiFbBR2V2DDyDw3OJYeO0BIzldbsZNfpR3y3sFOYs+8l
Yy2bh9LCQ8FVwjB7Kvq0n9+PBab4qauaia577EBr76smgA2khVKMpQJDLx03VY3kx5gyhPMpToyu
vGnUUjW2OlZG4/2EiZXlygoY8ZexkeMFkyplNu8lPVYsP3aysr6NmZwQIEAZsZIq1Nmhtbi0y+wy
/mKoXAlP0rTZhDAF9e9Kx/Cd51cGBQtS8Qu0Tsw7NdQayACwB5ltv+f+35haHm66HN/4y6uchDqx
CpIetHEiP1lnYq0kKSpiKNu3yz45mMwncvMh1O8zbZq2wZi1ny+vd3LOhck+mKsFroLSZx3FHb12
Sv5U8ZM+Lne1ikdt1OjGq3cllIbkmMAOgNrmqtAxkGvIOE2ofhNazaa0kmqHFk26N6pJujXU+prM
+PQpUkIKOTO8aAUMblXt5Iks9WbTaj4Dl/QDA++cyI1gaX8MA00KXbln6vHl5yh2cPwhA3OwM3wC
BAV3jU3NrdNVqTaQwTV5bm0Mq6qf9XGOqr1ZGKG1rw1pMnZMWZjMK7n7i7/famkEOXBZYTSjM1q3
LeERiiF0juPn7dTPj9XkZD9Sq0g/N9aYhjsrVfuvzBeih5elUzhh6ehgp9I7Qf9cdXkr3ToZs6Jc
zcwkZ8OZtGEMavSdP0Sm3ap76sVm2cQxulpvrKeu+qJZeYhzXJ/MhlelTR9vS8CeZtPHRtm9cwLT
/CNQB+sTslJtcOMZS0JXhoP4bWhp2l652l6uydX2oSvR60KpIVT4q7OlSMrcm6jmfTw/Krem0+Yn
zmjobjI7xndtmD8W9rCZMdL/0ZRD+0VvzOpaGF+/fIHfkdIB90DxJrE7vpKaCCoXVgaOLyVpvB+7
RmnoGKth6s1dml5BQU8KX7onGrCd8IMHn1mzo4NRo/RsWsd3QkiMIzWTi271qznR6iikel8U6tvQ
5hK4fMBPAgWFIQJrGCxwPJCAiU/up9J+0BokKKBTvqrm3a5rKUnzELnIa1cBDYH5ABxKbW+ePMnG
ymUjjZPDGJf951EqMxf7YvXj5VVOMi+bVVBLKBAt2Mka3TXqhTleaZEc2kFK91auyG+KaUl3IFzX
yquTSETdzkIgBSAGoGnrSOSMbY6vGrhL5jA+wpy+TGloeQEa/K4foitR6HRj6FsFtsU9peKysFot
jIqpDKsqPDTjUHkDS76pskp7VPL+1TMIQT9gZoOPsylAJfX4POTThC0eQysOyVTS46mbfDdk2LBc
flOnp45d4JoINgEYSdF4vIoEVkemU3MTNkHmkXdEt2USOq8tTEU3gzaeIDrQ3tVXuGMdWaWVjlHK
Y0u1cFOVTvXVXhDyuklbRPLm8p5Orgp6Jty07MjCFJiGxvGejCAezXzkdpeNcHGNHCs1p5Z+NNVw
LyVDuYdLes1o8cy54CaEb47Ri7iBV0v2RCRzSbv0AMG9ug2Mjs7X3EkZX1cXDF8u7+/MO8N+A2AI
i3jYFS8M+J8iRWRNoS6HFS5RZRs+OLhRv0/0vNy+fhV6ryq3vPB5Wj/FQZ1BpDI7P+ANi5dW2znb
wZmvvatzexHdV4wq+ayApI/fVRQmSoFlQX5QezvYoUwxv4VMkv/62r3gHqVDkBLO4yDBq1XMlikY
2hjkBzOYUiaIMDQt7XCkvLzK6cXBKgYvBZkY/pXrL3ax5EUt26I4lJm27HP0XFtnTpcdFk7drS6p
k1tjGH7f1bl5jQBzeuQp9F5GSFCRCCnH8WMMRqWCOR3lh1KxhvFJbXIzeUQVo06HhplcxftZrfrv
ZhUYyaud3V9GMGjYptA0BOBapQdtlbVKMrblIYvM0fbKymHyHFN1X/+J0TynJ0RqxBvEEuh4i1k8
B9Zih+UhGJYCdwEmRho5bmdOZlqvDorCbIH7i5sLo9Z1rqkleQn3vCsPRbX0O8AR81AmXXklrzyF
SYWnA+IovG3IXmDYHO8obhOtl6SsPAxJOt6YqZ7uIksK9tRi8VYdK3OT5/Bmgcdtb2LS1HawR/2x
IOZdCc+ndyh6fT512tqigbE+PXzbGTClVR4qZuvsx7ow3XyMiq0mNcFGSWmjXf5QTj961kOtD2oI
8n6CY5T1bNRGmFSHoIwTRFr1zBDh4lriem5XFLVc2MIM5KQPW6iZTvjqqwO6ntBbNCfxCidATaoG
1TZf5Pbm8q7OfIMIBCE+U6ZAb1zXRJQuSzM3VnXgU9E8ridtG9Pd3jkZ/EZ7kXFAqLvw2+VFzzxK
8gMBeQrFEyDe8RkibgfYKgo7okB1vAD7S8NTyWDtK6/szMME2QLBRr/FTKY13UKB1zwZs1wfyq6Q
/4jNonzKU7P42DLSb6tW8atZqYjEEGpxlzIGESu6VV5iq81IxLarA+xc7U6YaO/USadLo+mfLz/B
k9YAKxFXgCMJX2SsKyyyaWoonyE7A4bRtm2Y1YNHtYPGqlZTLEziLJc/mDOabWeIutsmqcorv8GZ
gwOYjFQNFhoR1FlH0F6th2VJ2gMxrtS2xOtG3WrK2Od3TqlU9S2uBtJTUcpGeaUaeFEuH9V2gjpD
g5TLQ6SAa8/0KIoTOEG9cchqJmdYXFBGhW0qvgdVeIfjZx3fOhXEqDcRlubNH5U1LdZeHvOkfVdY
C+I5Ny3NxfxDMduyvpcmzZn33aTWrVAmycXt5Ve1PoRoFzgKvCPBrxAl2vFh70eY1sOiZIfBKtrN
sKR3oRQcCj38RO/4tZWSWAwCDliRqAZPnFVVpewVa0mKQ1S2CjNes4Gpq/JryxdWwayZICWoTNRK
qy21WaV2edE1B+YVmp5hSM6eo/bBcKrSgynRXblz1oddLAdjjzqeyoIenXjCP6WOlQ5p07bn9hBX
krXvdO6YzBmULbqwwRvtKdu382hvm8YMPXWuoytRZB2tWB5VHkkS6RH3+NrvJuuqtiPx6g6axLQZ
LVPCnWQisLt8TE5X4Tt+MXkgKhKSV7HDbDH81ZawP2BQYz/USN7ymymvx2sZ8ktb5OevR0XlroCI
YIcAXm6u8wSzzaTC6fvxADzE3BxVSyZ73zqLfIfD7FLsMntJvuiGVCtvowaviWWDcgnDWJgBHTZJ
tty3NQiGiro3q8L4fTJo8rJHnZdMnj2MuMvMA0YzCEWdJHH71LSXfRjk5vfUkvP3cQA24eZNlDBb
2Q6dzzPur6gaZOmDZrZm8sqkiM0CG1D3CrsiAVIcHx0tRbA41cV0KB3pqzro0T4qE/PKF36izhCr
2ERB3ANYis98tUodqnYeVzPI7KAo22YyOt2tIb3Nm0UqMHxypglUTJo6B3/ecAqLQ6bx9e8TI7Tb
HZOtE7xYGqh17oStjbSh0aSNryyNxLQFTjKfLY1dUJRVtVfV9gjot1SHwbFJtnPFepTynsb9yzn+
zx/Tf4XPJVUAPPui/ft/898/ympG9BB1q//8u189F++65vm5e/hW/bf4p//8q8f/8O8PMfBaW/7R
rf/W0T/i5/+5/uZb9+3oP7ZFF3fz2/65mZ+e2z7rXhbgNxV/83/6h788v/yU93P1/Ldff5Q9oYuf
FqL9/fXPP7r9/W+/Qn766ZMWP//PP3z8lvPv3n2Li+6Xm+fsufj2H7/8v/bHc9HyE375Vvz+y3tm
rHTfil9+//aL1xcR6dI/Vvznj33+1nZ/+1XSfyPpo71EMoZQj54ckXV8fvkjRf+NVwcsJaByIAmh
hytKFIn8M+s33H6Fpw+9KRAebI5//aUt+5c/0+Xf6CRiBU9aQmQxfv3rAR29yn+92l8KnJpLttL+
7dcVqipwCebj0egg+Uc7yVVzfNDxoZ4wBY/uZFRy2a61gDOzDYND6uKmKZQh/wD8XpXfw1SfqgBf
b60ZvmtKLwalqlYUXbPMW/XzmehNtUPlyKZBMEQf4fj3gbqCJbxTdG4GvuAWNt7hgTckVd5onqnN
ZfxDGlq7i3alkQM7u+1iOO0N6mxNQoGLwrCQtpO5qCYqRse6AsmuSiXYcroD5gbTV4QF+NOr3y5k
QqtjDVrvll2iTgsGH30NzbmzImhkHY54vVvQVokSLxCygsXrjMyuDwlydWdHuSxZb2mn2fK130tc
Jf+6AcB5OFzMYEHLBELNrAlO0s/3qarVWsENdtcURlbO20Xu9emNBHHKbLc1fDN6bo2JJavu9kgR
64/I+/XhNmXysmV7ypAEpo3wR5oXpF0OzOmNbs5t8j5nPtonZcD3ZtikTRLja9YMRt+6VQDt90+k
8VVx5t9Gj6OI877M+d86wBz9lX/7g/4vhiHR6vnPv77ikzD0vkyfs2/9UYQR/+LPCIP34G/c/lB7
oOHCgxH6rb8ijKX+JkTEMNO5NF9ixT8jjP0b3xjNYsp2HPuBvvjy/4owzm9gvQQm0heaDzKalL9+
uf9BiHmh+/zrcNJBJqFnmBt6EDrgom2yOpzA2DPDvuV3qvJWw8I83AS7pHg7q/elej+Gt5r8VIVv
5kJzscbPzccq37bJbrnTHbf55KTeEr3JnLu+2JfVXciBDiY3/KPc5Iwzed/sxnJTK0SIgzU9hq3X
Z5tQ9/PIm0C4zMPQPzjjPpy3k/am5jJW9VtzIY1OvHR2+VqT4EPUfJFjppB69b6cvG6w30tmtenq
2FOSO6M4xPFXSfliFv4kA3KiA/Iz1S8ivDyR+Nvmg4JLuI6GwlncWb+ZwzdZ+G6YXBqRbu239R1B
/B8XMuf33wRt8TmfPFEuL145NcEJn3yUVSYERbn8ro2Nz8YQxgzj1q17dERfrQnlaOdsylrajZ/I
T4wHS0NQmYx9de3XOE5wxYtFmAvfBK2FUMOvodmiaO1Ka/XlXRqpH5VesZ/wrYjvS+3eiJPPMIu/
mZX+ARqD5Kl2s1dlIbPUsvkdnJvNMigffvoq/jx4P99lx0GQXwcEh+MlZH7i91kXkSW+DuGs2eO7
Rm3kXV/Fzq5d9M+dNu/zxLwTvc5bsIU/TXz/F8LWxSTq/2RcupgevS8LARP9lPdo/P1/RiXtN7rV
ANBCji+SmZ+iEvEFR39cxog9DDPgRf6V9yjGb+JvE8hgnHGviVrnr6ik6r9RThno69Ei/yNivSIs
rVJ84iSVrsHJJQy+jFZYwR0W3UcDMa3xYbJL543ele2tk+TSpkjM8AlT8eFGTeXivR6jf3JxCCpv
9EKdbmmNNl4tD7TBO3rQqB+bZXv5IIvi4ufPmzyMYu7/s3cevZEbbbv+L2fPF2Qxb9ndbLXCWKOZ
6ZG9ITyJOWf++u8q+ZzP02xBhN71AbwwYFjVVazwhDvoUs6C+p25jsnyqcISJFa6L4EaNfugG3oa
irX2WFtD6jeKsUWSXZ/jl/Hk4yGNaliYVUoVDcY4kO0NXxBh6Q+ZJDZQWdG2rgv5Z9bTAutP1CRJ
11cy6lFQpVpQRMOXyk7TQ6G4mLE0kaMcg8gdn4BFOTsMp7v7nJLlvrPbYYe3Sv/49tpeVh6YHBrJ
wDIRE0CiQVJYLx+jOE0MZIOc8qyYynzTCqE8z/WcQbJ2+q/Q27pDSbH2UdSl+rExAn3/9vCreFuO
L5lA0iNBPso4vF2Oj8l2u2ilNp2LDnZ1UOZokIrJedRV5GNL0x72vZmIO71upw/JZDz3xF0bH+Lq
cwO/Bisru0MU26jEXP6EokuVpc3C7twIEezcXLT7rrHfp7/7MtEXEykYp/AQoGlejjJNyVhr0dSd
awshVxGno6dGAPmaZFP/4gVweLGzSF7QMoLUCKVceiJfjrVUw6gBTZnPs9aaewvW93FKnQgtI8e9
HQREQ6+sIu3Z7fBvHRvrmBUK8k5KEX8NwkDku1jPtuA6l9VUOX8ICzwnKByS1aAkf/mbDBshzLxv
xrOlK3/14HkOTVDcJJP5ccrgTMfVlm6jXND1IkCW57uSHVIQWt1nwgEeZ1XZfC4nCKQA+Nx9SEkH
c7t4Szf1aigJX9fYvhQe6GhcESxrc25JNIYzvNvKy4EM7Req0ofJaLdkttePOo8EH5XolvEIZdcQ
jqKqkyoKxv7cK0XuQwFTEMOxml3QmOZTOVvqQbMbG1RgvmUi99okIQ0R2CDbAG5A/rLfapRJ10eV
kTbTOUcl8QZXA2VPdTnzDXPegnNcXfhMUqLl0KSAQgkG+nIoTB6K2F3EdA6M4N5u02dAz5k3YQji
Ra3+7e0r6GpjygSWdIBzIimWa+kAuxJ2NgxgqdOpAqpCXFXs0sRub6o5r+6XWMnv+sIpNy6+V0ZF
CU0qV3N7U/aQS/DbauLqnc6FHannJc2Db+lYfNehRB31WCg3St/qe3tW9F9vz/TqoiPAoJ8BmgSU
DBWy1YngVxjD4NbqeQjDYecifbZbOFI37x7lpWxuACgBXrm27CiGkeJPFyxnq43cQ2S2nefo0xab
86UmfXG86TXLejWXN5kckcvlAga0ZIbKHKxzUjkP2FVCElR3alfRrenvh+ag6X92tum5yU2UnSe6
fGjG3UzdjH0f4cN0fnvSrxwOGSlAGiQeo3u6Ohy1jqRbVubW2WmowYCmWsppL6g1vz3Mq7MGAMdT
KSQ7at0Vm1N7XAY6Eeco2ov4NGaefhc/OJ8QKdQ/sgjiVH8HGhz+cAsv2KKevTbJ3wcXl0sOhiGD
AtZa58J9MPp7G6HSaAPkfj0EtT3yODIXoMC0eS6HGCDoqSjUdV/1Sc2O2QK6Kk/hkSeZmb57n/IS
c/CJKzUa3mvEsYIirYGeuntG52g8pILyGozVLUcOGfJfPkOueAEEyZ1BBL9G9kGsamJISO7ZcQbU
7KKs7H6GIKkDVNDtpNwHpWgR/C+X+nbMsvxYdV30qy4ytfNCbZKkrNow/gS5C4JdC6wo3ZeKUfzI
zQJdgqLTFvSRjKgOd5OTxt0xwiA98JYaxfqdo3fznVHVw2PTW6gpOVa3RzrSkAr2ChaIYVyzV1qj
C1RPHyL3l1NS+9y46K4vHeavE2RKxAbPpPzvv110ppbW4aKP9rlos/JQQcbcNVW7Vfq/CmNZZe5u
8gS0UunVrm6DggZlI5zWPSP9ou/TQCsGL+gw+boVbjyeotqYu3skb5bHJEjT+qC1Wb4h2Cpv7MsL
CT7mS3X6VeuVhaJiO8VKeDZH4Z6mqW/3Qk3TG2Usi0Mape/OUpBioUgOpYrnWJpHXS5saSx1rjVd
elabMN3bi4FEJtIvG5/vemEZRZbMqIgBul3LnIlJC6ZEtOk54qWGAqlXpp/MdXCTjoP5WIRDcxcW
RXDSa6htcxhWGxfCq+PLtBSpYkm6Ws2yQeE7WwB1n7FgiT9UHQKhdSHu4pIgx8LeCdnNyY48vVSe
60jbkvpdFbi50eUio4wrTTMA960l+qZsdJQospJzFhneqCpHntfmzgaXQAVtrj4nURh71hxgcq8T
N1goNt3Us2Zs7K3rQ0ThkeqkrOZQc19D2EDGGCZuyOkZf6HlOMVd64m+3NIJfHUUFNjww4MVSbx+
uaPGJXTr2mZHlXVHzTGbEAtUE7FRnH91FO5bFKHwjUQ573KUbMxB/TlpeoZXjlHXGFX7JLe3fJ7F
a8NI0B9AlX9aFJfD9MEAwnNQk/OspOj/pmX7oJiN5rVha8Jryh+XqBqF586G+xW/o+ghy938CwBV
9btkve7KIJjgiwe/bHsaftlqr9TeNCK54ClLMf/SUkUcjUlfUs+k13bI4tT8qw1SbRcMWr1VWnzl
FBCYAoCUs5Hp+uVkxARhToqAnPOlzo497jUSeRZ6raJpXj8LY6cE5bccBHw1zFuO9qse1MshADsJ
s4TAka+2Tt3KvM1i+A7JGQUN88Da4fWmVNqpURHfTHEzP6JLa9+Mda/6NWIeMDyD+WkK1NjHKDX6
L84C8kbSyprOGFIsl2thUflxx7xIzm6m2qdWhb6DeN0WM1n+lcvbnOeE2OBlHEpsq1h5cO2p6YYl
Pi/OmO6CdIr82A3zE96zy2kpzem4EdnJyOZyQFC9aBRIugGtsHXYjKZAw3Zt2rM7Dn9WtgmTIhKm
h/HufFom3XrWuuF5MNpwP5RjctJ6VfUmdWjv9KbcEk24qspQhyG6lrAnNCbpzK1mH8W5nSVz0VHJ
F6hmq0HX3pIo5YfQbaMju779ysIVvhUaeehVUXiO4lr1NpZkfYTlr+AtpydLdYZ8d/WlUWEd81S3
O1kycOhk1N1XwtPwNKplfxjVvvbyIsQ3vckLfzbT7FvX6/PnQBE/C5cO8Nw9zWbjbhTMXlCXv30o
3gJZy6C7iBMVmCd3VcjQytFBVC4Ynm1e+/uwr5Jnq2270QsQTxFeYzv54EFU0QpvHmfzIXSy+tmq
Z6PztGSxIm/O9OxDXfTBX5HWqQg8I1f5YNmR3nrDOLSGl1uZVXlLOGifc2OaO0+Zo/IPpIcQ6CYE
V59F6PbIYXVj8Rkam6Z6im5mj+3Yah8pt+VgN/XY+CzaSkcVHC8y5DXKsP4rjLPoe8mL+jnLy0SH
M9QWCUreEZLNarUknSfMoH4aRqX4q8gb7Tw77mR6yIFEsWfoAW1cDR2rv4XaLZg5Yyt9V05W8dCU
TQhLUy94lUxRftOXufxcapH+o7MVXfcSpKS/6QN8qp2wJliKblh/ROK8azwwkqHqVZVKMLuwl+5j
tNm/V66d514xEpzrJhR2D5ZX8xlhonmiEoug4M6MFiXalVGV/KkWefBPavD/Wxj/h/Lmb4fwqrX6
1Ldt/PdFD0P+D/+vh2E5/4F6BWOSkAilk387q5r7HwnmILGnLkR6avKA/d8WhqP9h5oYOspQMBDW
AUL0vx0MQzZqCQCArkpGPT5o7+mrvpA5/j2YoElgIBIHA5Tg+pQ3xuXDEOhlpM6Ju1AKUI3Q75EO
snZhnzT982R0VeYNS4IrmV/W5JWPKpvYegocJ0lusKNw58dGQ5KKDI2oxcn3IwLow02SN13pZXNH
AagKGvVjWrrlmaDPwbEAWvHMLk1j81BGVmB9NCIzCHxqb0pUeVoBLsrYSVH2qfXbFNhejp469dZD
XYv+yVwGpNFcWK+PTtG0310V9vIjqnLJragmbdkNrVqqOyAelnHkxIwIzhq9+az1ugz/El6jvTqC
lvcoXGUP5ohYj5fGMTfMaHSUIYq+SFTPiu2o9fFWSp9QRxAtP2GoMl8Vg2adVG6kzPCtdmapoEHW
heaB4ArnLV/iy7z+n28jDSYIX/nQV5outVIMgjWzEyqTYdJwMzYN191SuXd5qjXx/rdd+/jPR/+9
9bmK2+V4Mvaj6vvyD8WS1V6IifIMrTMSDzvMhT73EFLWp5NljN9UkYuG2zOuo7uyKOfs++K22ueh
GtvneWzZAnPcTuPGa3YZwvGLoHPJBIoQjn+Bc3X5i9pQWZIwLCCctgm+pHtDKcUeKyWFHnCij8sR
K4GoPTiZ21p7AaCvPBS5HW79jBcxvN9PCXz7F7ccuuXEkxzNy99hWQXqFVkw04/H4sLalzEViD/S
IkVbK4067AyMQAlQ+Adgmd5NoaX/VLWs3muTAogoTSux/K2HA6k2W94xwiOdwagukGfuq+WH1umY
MRidPkafxmCZg+/mgNQHRgKiG833CS8g3MiJR0GYawUFNPr/q1RCTZwIHwizirw4dsq/FmIZJMMi
HbuDt/fTZTQoB6LQCPyDsrfs37xst9+LGIUesDuCnEXDTsLa1ak22x+SMpeUfBBj8w55gux99jkv
o0q4Pa0F2oSEhqtiWO6MdVVYURB6dPLprMLC93WrDPZN4jYb1bCrGQLpp3nBcUGNCJuvVawVglXJ
RJohPRxY2VTtNXRggptuLgbndq47U9x1Pan2lnmADCQvdiM4G0IoxFqQx5F0icvdSIqGPC+c2tAz
QoDWk9amj3mQ1ODG3KA9azN2xl1uVbxZ/wsYeuV+WF9HZIW008nqyaWo/zmrw7iIfJxLiLgMqy5L
vdPMEdcyx6lQB6Nz9v3t0eSRupwkSrZS20miinjvVpMkoxYQCewk9BYl7W+aprKPQa/rRyXI3MeW
nuQhh6VyG7HAu7eHhnR7NThAI8wxUXVBZwNM4+UKB0Fai7jW2T9tMFVFuEtdA2+RtimWFJU5x2hd
SuL87iN+MnbHLgtToNDaoGSgDtOKlkLgGW1nacRbaWPNAIuSoXiYB721dmrRg/6pJ4yneSbxw00m
hDOWEqWhsp3KY8AHzj/iytZ0vjVqM53HPhjr+anqVGvxRGAp1scFTZbllx7XlTneqK2VzhqRMLS9
L4ikKsNPqi1L+GWkK++4sNudJH0wxlgYHxDU1eqPBPvWtAtFWFrJbsz00L5LVXuexW7URifA2A8M
4Ic2LI38MDlT3WB3sMQCt6teK2LxNVHKzhpOrhHmRoUPq+1mXyKsUmMPSa5Fm/aVHRmNl+jLtDz3
joBUEw5mAf08RaDMwC2mjxTnVGU4Rtx1oapHH5rBKZKjNZe5ccPfCN3FR1CrDIYdzuwi+ZbhfRDc
i9Bosn0KoIiro1UtxSk/RHbiJPmJnWtP476a8IPYd8uAx4Y3RoqSll5vi8A8ZLXIJ/0xx0p+Nn4V
ulWMzU1d5ZmCYp9eoI8PosCA4bvr9WA2hBfOmAGdwjhXnJ+ugmXNF7g86fwrtUx0WLwJWaPqm2JW
YJLiqKhrcggyg+7gaqPS/iSysTt6UkuU/HTdLCtuFT0gJvGKPKnFvTIVlVV7MXYW5R45+4mCutEl
aeoZY4uaoEicIvtqiEUbAV6SQt2K3spdtLFHnF/MkLreKSoGRflgqXPI6wOAP2o/0Qaci0dil+oX
Yb/jPoWNMkbWrq8oKz+3hh1GvOmZOmSelU6z+kBUGIunuYARfDdMc1v6ei9m2I+pFZu3Dn5EsbWP
yTmmL3PVTDch3k2pX9Er53dpaWbv4ipPRvM2sovmc6zmmnsoSbMchego7K3lm1MoFES9ik9W0pVw
SiM9jlqrF919Wws0XY5VEWtZtcc9KKK67oSmdsgUu4x3fW2n5u0E1SM7jRVPyrTL7C5GoOjWwTnC
rg924hrJZ4BdeX9eomKZkcVvEjU6TXqrROxavJcmPxUo+xleqyIXY3udOer1V9H1hopTcThYeHsg
RbGUHn5JZjl6PTAdW/f6sbMssIBKPu4bfTaSkz4NlbLrKpwy6B4oqSoeHWtmUQEH1IvxDTFWLT7x
XaPqYASkqvv8xYtLpCaxqDqOU/LXhNav45t1WfcfKlFWxf2C/+r8YOX9CGAw1pWhhtk31pSHAnWY
7ufS1iJUA20tfID5FcZnO4vDtH8Ykrxy2gP1QBThduwLYzpVsdoFzresCYP2SxB3aSy8BfbzhOmQ
jRLh4DlT4EZf2sGI4xvLaKuxv0WA2LJOQ2pDafedCSQ88it4OAWNhyeSXX4s8VCDgZC1OpeEtwR4
Iv05j6PovvbIesVevCiaes7tXu3vIHSU00lpUOB5UIKoezKm0TC+zwgFZVtvobyJ/30mSJ4kiQPQ
MrJLBBtXXD6kjqJUcQLbr2el3pVF2p7avKz3k01ppZrsLVno6/FkX4ZCLw8Dofca5pRInEE/zK6f
BmN0U8CnuilttaRby/28LPqWGM7lMyjnB1EY3yNaNGw4uqSXL5ESWMPQjY7rV2np7NiNkz9Fw7Kj
/9TeO72joZkZOHvF0rd6UKt04GVoCmgAyAT3pnSjvBy6LwkpMrGQm/VRG91idikwfJ2y4E5Vo/qr
ag3zKQNtga5L05i7MMnH3E/qpE33VlloG2yvy7oWcR3xJCpHUFHR75Qcv8tfo4WYSDpjEvyK5lC/
TXpNnEyJbXj76b/8vIwCk1fqnoGiANZFGe1yFBsOv25CXPhVTGPIY6XFc7svM0LKY61nPcW7AOO0
jXhjneW8sBVhdSCqKe1x1qAbK5inqrS74FfNKRt2mVFgd9sINZl80vMRjH2cdsEOrtlCahrM3ckJ
aMw/v3fqaHRgbyoh1kSWa73BybTqwNEjGfNECInpx2pCYKvHItbRm4ea1DDMPTgCer0x/fUWh8MH
RhxFW1BAnOY1cEXo4SwE/dobfYhhegUR1bujI3rtqeB2jI5lizrrIpbB2nUx9o43b8/7MtaT2xze
AykKfHEgAgBLLj+5IkKrp01m+zM8sZtMF/UtkKfoQ1AQI21sr1fGoqaDNKEs4UC+WZ3mTHSLnpCh
+oTX7n1IkOVNppk+YjQ1Hd47LWjpcjtJ0wE4pvI8/ZZ9Zb06UEiVAO4otKO9MyXZXVgqdeypeldt
tKcuM5KXq4IH1jJd6lUSrLtKumYRQ8cpwvDYJo1zSlDb3dFdaDyEGoKd7hQQCoFr6xtXwiujglUj
I7HRHRCkJpdThCNH3Ksbip+ZWfexFGI8WRadHDGp4hN8lXQnHS2bjW+4qvMzWQnmQr+JxiJdXuCC
l8M6Bfp3ENTjYwlrWAUWPozE9GJGfkhoueW7uGIG4U5byn45ZFmVl7t2Vu3Rc9UmeacJuPw1UL6Z
PLxNaTS9vjzCfgjCyiKg6hMsVHYV9g/ZeejrwTPnOt7i3F4tudTNIreCZM4TiPHu5dyThuq7gOl5
xN13aPw4zesdaNlxZ8xpvnfsvP3RW7GzpR90eS0zSYTEJJQbCBZlHl7fy2GNoS6nqA7a45hO6qdE
F+OTWrRjuev7XuGW1qytES/v5JcRJZSZGgl5NpfhakerqaboPeHfMRy1AxIkIT4JiX0sRFd9ZVM/
CyMpnvIunO5DwrmPb5/d9Y3IZ6TexXGiGsfltMYr4jiqZrUVdMe5JN9MM7oiaVy2nzNDDB4mH5o/
KpW9n5J02jhSK0C7nLcAG0bKLeWGyL1XD2AQFkoYDdNwHPpwOcZOt3julLvfm2UAth4b+W4Zu3Tn
alV8yIZeSn1Y1jGFZLu3Y0ehwz6APg4EHqNvr8nV1ck2AvHMpwTFyVWzujpLrFitpGvmo1JP4PDM
vjoq7fI3srhbN+fV6jOS8QL1o24PIG91vs24zoEJLPMxixuxmwqh3i5R253SxFT+7JSovUfx0fIU
O+za917aDA0HRlblpQDTuuhRGmHRGAu6AxTUiPHMoUthlod/Y4Pj/Hh7PV/OzEXkjNgSkrUAjGn1
wwJefWkDK1sEE0btyAq0hz7TJo/mUnmkT5ee6sxqd6VARks4dfhhcmft2LWJtXPURv1ULbPlL1n9
1chFtQvVtti5qZY/gKSJfsIh3Lp1Lr8I0TZtdG4d2ocUvng3V02KLs9rBnKSvRnTDr7NFLx+/0Jt
RuECCIP0D7uy26d8UC3Exdx5VDe+ynp4rlaAMqBq5XMKEHu1UilaAkNmmws0MXs4IV9afDTr4e9U
i4YjxYNs10aje1socee//Y0ub1veGDmwTbAL5hV4whUMDI3G1Joi1UcHtPiRKemY7yO7QdIVLdFK
9WrDGs4xnaIvb497ed3KcWVCJYELOJ6xNeTl+FvsoIm0RHpzhv8UO+JIvR1LsHISxywq+dLtmJ3+
i/H4xhxskisKfpfjVTN6pWVAFd0M7PbOBj3woCQ0cJol+RZpk7pxvb42PSEL4C40V97O1VWi6FWT
9U6t+paBDCOOeWRtHbQCD0ZyRcXNCraU6V4dkUqtBkua7avLHfbbgpad7sYa0bs/Ina2x99DYIiR
Ngc9GLBZnowt1Xq5I/892/98QL4bPgCgPQQx0uV4mQG/eaoEC2qg0B9G8/BEk3zaD9bsbGDNXhsK
CiEAVN4qKfl4OZQEcPaGCBZ/gZZzQCgdickSD/JDGkyB8q5H4J95cTu+uPBRjl7zQTptDGfDiTU/
GSfzvjUj596qm8orKNQ9vb0nr+fFAyiPHnEtD6G92pP5aFmYjJuqL4C1HNzITT2VRv+XtK23GOHX
xxx4kETugowgBVvHGp2LrF+CeJCPYXN1MI3e2DdhApFpJNtXzag8cL+k/vvnR0YtvxyfCILY5Xfr
rQiZFKdTffCrNg4xgVF+ngz0q0/ERfnWw3Z9haK2ijoWr43EXa5fb+H26RANsfBjW+nrP5AuRycL
tQEH/MTUtHq9zyIBJxc3GTP4VI9Nl8UbE35llblOKWYyX8laWk3YTAXU9KHXfLEoLZ25fNoV6F36
NYWAHRaZ1sFYkuxdiZHcsCCiXrptOm8XKg2Xq2wvGYbgI4PWlh0fZAngFPLa3c2xrR1qfcbAuJ+b
dx9J6hgcfApUMlZfu8CxuD1SbZPuox/yPODJ7GtzYaAw57QbWravrankRLB9aZUAWb6cntLGU48d
pu6rOsG4KLL+RN5EjJily3FQ8MjQlcrc6Cu+cjKlBwVYS7TmSNpXmW0MdCAxl1bndZqjPWY1sN/q
Jb1ps9o8vH1Iru9tPplKL8FEeoPxVnsm1inkKtas+SDYxC6KFf0D5nfjfYDnyFMm8i0M2StTY4dK
tglKPxA1VuuZW+WgjAnjiTLU99rSTY9GlP9IUVK+eXtmcpEuXwhifSI7aGWAziAfXX452kZjmmJf
6kPf6Z7Vvsg7T82KZONlvx6GygNVO5poyIOgVHM5jLu0+dQUoea3uCShvl5SYtoh5a5/fXs61/cL
dRXANARJFJHg9l6O47jKpLSJoflq5rAnuIj8hTLwD2QkkbYNoLZQ3xr8xK23CrTXW0SidExTQ1sL
mM8a7OwYXZyHy6T55CXaARas4he1/os2wnRbF/FWsey14ShN0pzEGMUBS3c50YLEAd17iwwQ8MSe
U15lh1FCdNEB7U91PNtb7nbrEWV53YB8SFWHEh0R4eWIgVJDMA2XTpJto93gaj97Yd9O6G96tKDH
d77wjMa7TmUMwAuQqDVou9DywS1VF+6hMqinmqDwqOQlxhp55iRbDlSvTM2S8k+QadEfYIdeTs0k
Vy2jjsGqXkRHUbnqHqfs+nYZwmmnVuWWgeplUUGWlpkcF7MEg1FmXiNEHfxygFcb3WHSOqx2wwoF
IzcLzP3c5wkm1Vb7ECxNcBKtZT7zb1u68+vrRY6PjDVCu1SuEM5eFTXalNhpTJTu0IXZtKOginUm
vV2pH7sli3k1FPALYK4S9wEWAxTT5dJO7hCAfdCrw9ha859DklXRY1X3bXJrAYt+fPv0vzaYCxOP
jj1UfFARl4PpoNV0LTaIk6oiuQuctDi4Jd3Rzm2r/buHesGyUqdmc6KldznUBKDcqC2jOiwaMtZe
5oYDSNIA8WIPQHzx17tH46Xm8PH4MNra1zftrQAQGGcvpJ3ukyY557R2k30XFcant4daP+VUVXgO
AM6wL8i210BAuJtghQO7O+RB192iuXYit0CwlfgGsLye7Kpq2RKdW3GuORCUc2Q5nGqiznZZ3y1V
o1WhPvToC/VN/xEigHZniz7wQbupwY7a3HzIFS0LvaGbik9ZYdDdy8po8ezKLR4Vk23ltXUdb+yn
V9YCnDKVc8lulSISq4/spl2h2fTxcSYufNTe3QznPzSRQtpUN1bexH5TGbBr3/kJ+HPw+IiPkZSF
7L26jrrECHVQIuMBpMQMzg9AodEgvwpeazmpXUPVQes2HuiroyPHlBBDvgSpgLq+3cNJmaK0HA/G
nKW/YtyQ/ZaA4VRWavvezSyHQsMDPx7ZQV2HHPiilpE5x+NhREbQy/JM3yVDVp+K2U434tLXZkVy
zyEFDS+N/y4/YLzgK1NbMBRbQzE+BIOFdnmJ4qhLoPjOYJt9C7IXuUt6pRTh13C6SEfzUPT2eLD1
eridRFr7A1p9GTSTeitnu9qXcizZ7+B8gkySgOHfywi62fV6XYXTQdRC37vmUns1aJ2PURUHnpaO
lp/1ffHeG0/e4RJOJ6dHsriqXcTQODQt6RkUuttehUL3gTtoPmgir/13HwBaOdwHHAA6vOvgRlRz
V/QOBd1RzPoPaPVTjkgurM+pirvPpaFOx4Dk9Nvbo76yWV5wkBZRB/Hjuv84mulQwsEcD1U31WAS
k3jfg17ZWVU5n/+bocBF4r9CZeQFZ/pbHcjIC6rbaAEfjFgNbxZL4V5xW7yWaKNvXCbriJh9yaz+
HWp1mdhBpARGMY8HByOi+8ROi8obqqDdWaneAQgLokdlCJOdgiHMRm6xIlxzrcuxAaeDjaRkz765
3KdN4sR21S/joUOfxFMJik9uGEaPmT1NwIpzFtwr4hbtBXyOF89yZvdRHYLpDxUKyB3PRXKa3aDa
p7CoaAhXNMLJaNUt69p1cvLyM+VrxzOObsL6wwfkkK5BsfGgdd0vrcjmzwPWHBvvqnwrfk+05CA8
qlK8DEcFVuNyLRYrS6ne8MnbwU5vK+5g32kC/d4ZIv2gTbO2UXG4ijHleJD7nZcU4crOHlBVxdU6
MF5tCL/taGzrvRH7NAC0veP0rc8FEu7aEch/Vk1bFLBXriiGJ4klHqPy8MIw/G2H98aCfVMMlK22
puxBq7VBPbaWMz3YJTa6nlNm/R+d2ZnGhsvqq8ssTcZxRJeiIqsbHyHlcRpUthw8oX5PYuvctZ0t
9laeNfshdbZ6Aq/scXjLSN7LxxrC21pUYGjBNC4WQvZVXWeIWiJS+5OCp/kZPsTUeUPWGP4MCvfH
kIzDvkIwtd4rqlH/LGcs25CxwSnQG4KsOwzqFGM/SyFjHzqT8/d7rxw2A6miynVJnW+dGbcYR1KS
HoaDGEhLqyWttAP5Yqnt0NTSg43I6fozyGiCFiL1IOjPa2UkDpuOSN84HvRUHSAYR8ufMDS4ZYIu
YraK9vHds2MUXkMZttKwWJ0urcqWbFic4UAfT8CUirQy+MsYSynPxxcq3z8cQoNk+VSgdRAPqwe4
Q7al7tWkP7RVnB4X+mtf1RCgdSDCJNm9PbXr2wkHEcoKZItMkF12eXEAoZsd9DHnwxiPoNkTNwoB
C9vj17eHWcEZ5GV9Oc5qCVtjbEYrXubDABxq39pd9Kw1alKT2wjxq9ZbW3nQ9FILvFmE6s9wyaaP
iVvSDH/7h1w9w8Q26MbL1aUMTin0cr4ZaZ1eEhn4WtBG+xy0000ZIbIwk2Ae3h7qapdSzn+xIZJO
mpDV5dL/dkmBxdVLk0sIUn4ynCan6J9io7FvdK1J9smixhvb5pXxNFWqOSFzhJzdukcSjSmivAgS
+E5rFvcqX/usO7B4cJozH6LeVqaNx//qESBkk/ocBNl0MFjYywmSr2VdMSfCh09c/iHi0HpS9VT/
FRrwTrwcOCi1OJWuyW3Yu2p+08bKsvETruIPOTpcWC5JV/ZtV9uK6M7Vs3QQflhE9Z8FvcsPMGL7
Z7XtynmXTkm4b3vVgpYh6o0tfb2TWEto3y/cOk7OKqexo7E3AmsWPp0UyWJC3PcAzbQ/hTnE9Y29
dPXgMU9U4NBDotpBF2y1bSsdIqqxVMIfJqXYo/OnPLGiv/IZQU0TIt1NNmpb5PLXJkirgPMIsAuj
sNXamjA/R54e4aPErdyls9KOOE23tvlchoHqbDytr2wmSRnHt0I2TK/q7fggKKYxdrpPzhrvDTFP
d0vtVPtS06tPejU2vhqm2cMAVc3LVFH+fPuwXt2DbBQgqJCuaGUQpcnF+O2whskSLH2Vaf5ipTm6
XXZwWlzEyd4e5fqISrwNpwXyBo/l+uEqjF6HESF03xWRKpXVkr+txlbu06kOHqK8fZ+yHV+NTrBN
vRosK0V4iNqXs4rquScYHqERljSe68YqMDdtkcCnybB/e2rXu4WjQI2TShIPEs3My6HysuqQY24N
v4Z1eZtS3DyRiLQ3wxzN/ttDXa0i2TbMVGYE3k9qFF4O1RUNCQ58PZ8nyxrwfgcnYxVO8ai15ccg
SYf3To3xkKlDxwZ/FbKN9Xi2iDt76Si+T1HwRQUktgcDj5+G0TT6ljnU1UlnMGTVHBSrJO9r3XdS
7Nwo2yTR/FkU86fF7dovebaA0dWX6JYcha50uSwbUcArg8o6KrYahDkYhqz2Sd4rDbB+ZgjSsbqv
Ble9s0rbPHLpWAdM6Od9Z0INffszXscE0vUHv2TyFaCq9roKj1CFay8FU9XSJnzEZLbZIWHa7JFa
j70kUtRDmS+TN2hG6fd4BqMZjm3n2z/iatvyGzgYsjlN2Rqc5eVeUosxVBBR5tvmkXlALHWg4b9k
aLoHW223qyuGoWhekraYkmi6xlBWvSKCBuKGLwI3fRinObxbEqhMb09o9SllWw9AmbQWo1sKFGS1
WdNEQfTJ7PIHS4WG4YXTWKL+M+RVcKjo6ezaKjRuKVvpW8/F9cCU2yiqMDeuNnUt7F5HAUIrxpQ/
JEHEi5+UX3rqYNCh80C7idMp/iOpsmmjCLC6Cpgt3W/qRhwVCnAs6uXnA42FQVsRFkg5OHPuYSPn
tn4WQwXZ0+LXEbLHZ+3dK8yYONwAYldpR68N+IYaHc5EjYsHaM6ar2ete6PqcY4AEyah7QxIVEVY
amPQ1T59mSjmZy8Sj7BB1+proCXnQgUT9lDP4Ogg5WnGIQz75SFpAmcLBbnaqYgMgdiQDXf6N+AE
1hXAto6DYA5N9xBqxajTsf0f0s5jOW4kWNdPhAh4swXQjqCTKL9BaEYzMAUPFNzT3w9z7kIEO9ih
c5YTnFA1ymRlZf5Gj3nGo45t34g7++XbBGw20UweOVxTwAheL19raHExlj1ahLEjDpDhzI+T1wMq
TrPuaXCH+kbZ4up4FKy4qijE8Ch5PR5uSKCXG8c75HXjHPuKnVnVhnOYjGkOFMO7Mdx+0f77PGaS
dwbVYd4Cr4fTcIB0U0X3DoXbtD+QSW6p/tnZKS3y9o+kd0gOt5mkZA4YgzYqcXU/lNX0cUfeSUPa
CutEHzAkH8obZehdus0oG4iT+AsEn7xw751mtVBjjGr2DvOQ5H5i1sBZUtUFkY7iqY3V8LH24Mub
wFkP74e1t1uSkbfuKQ9+Lqk9JJxu2+j11eQdzGRcHif++7Bm03j6v42yS2IQb0lkK/HtJI5pkTVp
9jG15S182dtduH3Ltv82lB5v79drJSZS2srovEMl1SSggmkGSU2W5FqDPCAgdqtIe23ueBCCiiL7
5AbabUOew21n5rV36GE6H7M1RUJgKvTj+3N37at4OLPPITZh4b4bRY3VphvKBCuslfaVwMAl9Tu9
cg5rTYMNbaj+Vqr05rtAJvACUzcNIsTW92951VljOQ+aOK6jWz8M9tI+UI6+JTDw5hBvGtQWsIQt
VLHld6uVCM0eDJHkx3bV20C1uUMBm+QHd2lvNUF2cl6cYsYi3HKbbdLIoLNf7wwSEUXp9VQc+6TN
Pxd4s58sTyprUKJ/8MMs5fBM/M8ORu9C1x5qK0Z7qLf/Scpejr6iKciNvb+q+1t9+0UgZlEZZI7N
N1jIZi1c4cWTOEL6LS+l0Vd3c5NWoaqrje9hUHG3mLF3I5hdm/LfB9222m+PMZElddfgrnNE7aI7
DhqemrHSDFhngGp4//uuDrVJ3eFDydftQcFWx+wqKUOZaQ2INYs9QBkt4grnESRI878YjbYMmRnl
c8yWdlFaxkJC+CgEJZosLTgeHJWAfKqnXG+qrbgxj2+OJIsH04+qpUF+RD/v9TyONS93vPLEsa2V
7FGtTC1Q16oP8jKtj2Xu/CGs5r/tS0OZL6NuyRW7Hdjf1i3BKnc0dW6BxWx1LI4mZPoypwpbtMmO
76/bm5to49CRZvJtANje1Ej11NSTCvjHwaycxP08Aswoz5ZI6+6Ch6ljBMXcx7r0SR0V5zC203rL
2uTKzoGHRrMZK7utQrJLtBHYQ84gl8pBjyfrV9zZuRbOpYFFq5XVt2iyV1YSCAOfSekS7sZeqlZN
1ol7SSWTEOh6hUaVIWI8OE2K+IGcJs+nsrjeEvh8O8ccDN6DJDC8KHiWvl7OqhDItLp9cVwQhgz0
ch1CdBnlcQXQ8MyeleGQdGlAsT8J/2x1QQ3+zykBpAU/9s3LMEZzQ66GjEpbkE/ouV7/yDyjf8xc
+MAh/Z/eC2y97KJcpDeLivuV3TCL6ETTSKPQtlkBvf7uLncSJ45TGaklBLRgRXzp797NjAO43ltS
+Nu/9VvjDjgEY4FeBCbFE5ga+euxsszrRdmnY5T0o54eurE0NURyl/aCyoU+hF4r8vyjCwTuMuRV
4tyTMnjJjbRnH+T5EWDTEAUnAAKi3OepRqoUQnj5FI2qU59jT08+eIh5fMyb3vuwzspwtErd+/j+
Gu+3NCNRw+H9tm0uvJu2VfgtWAz8mtVp+jlKW3Xu/unxLSlUrH81YzgoOajUnxVhJH3+v426C4mu
SA1dxPEUTV2+Itq6UlgNp0X21lfT7omIPKunT++P+XY/IQZMu4oHFbGCh+rrL1WV2hr1vliiCi6Z
e6iMDPbaJvu1maT2062y/JWJpRW8YeBJIGhV7oZDer2eyJQXnDkq+zRaQ/JZoCtzNy562gRyybNb
KdLb/bOxyGiJAlIlG9s3rNBk8Fo3zdZIW4kUvqUNU+O3/aBd1ERV7PPIdfA44A51i0e45ZSvTw+C
WXQAtxInYIA9ZyrBtcKKs2VC20VTPtPxlqgEYSKhhd1aPUMqc87aWOb6c9zHwBCxu9M+0z11igso
qMH69v467+MlO3oruNATAVzFZGx//21He2Au62pM56jNZfK9c0RyJ2r1HznVyguHynkynDj/yHXV
+u8P/DaIbCkjyDYOE00Qdxeo11yWfau0UxTP1XzUMyMJkQ2yvzTWoN1XaZp/QJ+neDDBIjwpIOdv
VfKufjhcBxNCJ6TdfUEWtKnWWQ7LYBLJXtbO9joAcyOCQ8nY2WuAKF/xpTXa4h+8+uov73/8lc0H
Xw7oChk6GAhjF0fSGd/aeObjC4QnD3NviofOm3XHl8s4hJM19C9Jo3Y3nvZXR+URR2d+QxHvM3Xc
Pew+X5wpSlHgPCDNskSOcMWmK97gBm0M1YmYKT6//637kinXBd0Y+BY208wVpe2uJqGpqTUAfIjc
WF2/L96shlabZzXqn6mHPNecHcZ6To6WsJ6ULfPTxkKe3v8RVz8dHBpXFu9YHkavtzn4e6KmK6dI
SePxp5cbP9JUTXPf7krlY4za7Efoq97x/UH3b73/Pnzr8/EOQeRxz6ZTEZNbtcGdufAxxVEAksPH
GtL41/vDXPu2DbkMXEennbHX2fY0g+bCWMyR1s8d0ctZMKJXFbUJZj1zksDohfa0zMp6y4zgyh2x
lRMB4PLwQ6lzN6ngIudYZCW72GmaY1wO8fPUdp+qvqxu7Nxrh5VxaGiQqYNE22b6tyjFE1GVej/O
UbN27qe+XZbPei3cs5IU+nR0nEU+JXrn8fbCv+hGwL7yldz1iC1uTgB0jHdfSYsNC6NRXSLdTT3U
FgkZ+pjX3Z2xatp4fn8tr0RFqrMEBBoM1Kyc3VVvpJhJJ1m/RFo36rxBGiNMzUG/8MSWpzErf9EO
NP615/yTaeTN3+8PfmUj/VcEh7cESoma/+tZtnnEryNu6JGJ4HZ8JKdE9NTPmhbNhnmRXnpfjZlU
Q2fK1j+TJHe2IIFUNewe+qibYMUuIkoj73NXzGuUjol80RavagIeK2I8meuSRe7gUmDA3IpC9aCo
rZ9nY3UL9bYTt/v/P4JkaXtaA5Xaz740kS4qOoWl9tyRkSrPUsLEsMb+oQLTVAV4uAKyDlr8yKsg
WRHuv1SrljchVQhbD8o8T9uDKRDo+qFWRdZGIivqUOqTA+bn/cW6ElzATJggGNj8HPzdhNFn9srM
0OdI7ablm2vGZuCo7Z8SQf5bF2SzyQU5fCSDuz0xoh9iaWm5RNQXcuegrWp5MMFCS4Qdy7w6zZZU
bxRsr5wBuIG8/altgCbaw2oHkTR5ri9r5FEbgkKAkPnjmjvqY2WW9RPJI5jlWXM799xt4nh501pm
+P7kXok3QCRo6sNMpgyxbybQBPYUuodqVE+ONmBEMSfWg4epPcW03GqeESsx08CtXUyRRw7GjQLW
TmDqfzYiAZV0mIbq1md8fRKh72dFjBxh5BrJdEpxOvuGL3tf+Z6WzYfMrhfVt/Klj8/uNMoM0Yt1
XHwndlRfemK58f64tiC0dkmSoauhM7ALSmS3c62VqRrlaymCvvPMu75B8VVrkHCf7bTiolGqD4qb
NU+x0SY3rtFrYWnTEt2K6Fv5eTd8OuFrlccQICgjOn+XcnXu6e2kd0WjaXVAjoxIoL2AUbixCbZ/
d5eoUz6lZLOJfrwt1bqKnsJEH7XIbowpzvy6Wgv52HHX9keUxZTBDPTGyeJ//3zvgXUl/nOquet2
J242VFQkFU5VqgiYjkZqvIB261DsSe0QJEN+6Gb6g0YxFze4AdcyNZpnnLj/GKtv+rCWWjKxU79G
IwUoFAZVIbOel32nOZ8KT2AIlY/IVX0fZDml9wl02kAVs675pRFr3Y1799oh2Fp5NG3goIGYNl4f
ArNCVqscG66EqhP+JCDqwnpD8B6MT4ji84CDytidpsn0Lshyl3gfmarfG3hZvb8i138J4M0NJgqh
YQ+0qasF0rnFL6nQH/y5SHCNs8B2t++T7JwtM/Zqil0rvis76uBrttR33kAhBFL+fCvuXzkNENR4
KiNzC+Zir7GUcn3l7qSzRuUynC1qawcoLOsUKhiYPeKpWp+UCmDZjUN4JSICcSIgbUpgWz70ejGK
FOE6+uNLtHhKrwZaVy+oj1KbSQ617VaWCBDfeepdRGFD2KbU/W7cd1fSMKqIdGloJ8O42L/XDYUK
tYTuE6WLah6bGIZH507VN7d0bgHFr34rhS2qH1u5do8sMeu5g5IvuIAcJYlwap8jlxPZ+BMB70Hv
a036/YINwYcG2d32dGO3bQX1XdyhabgdQ9IwGlPbz/s92a1qs1dUjRXWxiwYzcV61DSBVKubNNnd
rKDhaOt282SVJo/kmeq4j2ImepTv/45rE74pHvFiA96DkOTrn1GodatZ/bbpTWRWq2rJQmiZOgr1
mXLjk6/kMhRjKIfQ4EaEe8+KMGS6Shxt1Yjnkv6htYv+oGfaLUT0lWvs1Si7eJK0HcCKgVEGu9C+
Dsg1fqvguR21zh0OsSbdF6eKi4uDbkZotOXy9f353B9cgNhs0Y04B16Q79zFddK4zJrddYlEF3sP
roONB+z1/Ku6lFnOTaLjsSd745bX0/6rAdRBNaG3wcNgo4Du2jcoG6DVZKTYl6clNhsJWBvPRxx5
OYlyaGS4wDqlVNq0L+3gYrtcCKp0N3CS+620/YYtd9xor6zvPmZ52tR7i9CcCLHl0Q23rqcZgigG
p1GI3hE3du7bmaYfCSkblza6rQy727mePucoNjpRQrr+uURSOChRW4/s1Zs+IIaqHxCN0m7kbPts
YfvGrTrMXLPMgBdfD5q4Mm+Qp3QjAYIo8Bp3sfxhGJwXJH27R+zUnFvKIVc+ExM1Kme0cmgk76HM
bdOzdGnjRku8iECVg/yQzmoXWRL1ibDD3+QFa6NqvXETXB2WsITuv8cFtC83CGnVmKilbpTkunXR
DDkbQTaa3geZSj0s4SwGS4zd0Y1F3ccI5neDS22N3Y3As4fB1FgIq2PmsYcaWwo/d1IPdhg6Rbcs
Da5sVgaiwL8BVED6bX//LfyanYyHJCncqHQooVTCk8c2tvRL6a23QsLVoTbCImIosBf3QL4eL8bM
m3I3slaZPvQdfj/50DbBhPj44f3oc20o7jNetfT/UEbcRfMeRqiTt6kXNdJqH7RN+gQgk/V1Gp38
Rhp55STwLVsHd0M40KJ5PYG86LxVyUovkkoyPnWrw/HTvTiCq5E+983sXd7/tGs7Y4PS/6fCv+E4
Xo83a3WV506nRTlisN/6YRV/x3o63pjAa9seXUvatpSQQAzvzrdGGaZMyOoi16nRq17Kvgcr4qBW
0MAvik+GFVen0cjcWwCLKwEcYTXqQSBG/iu0vf48J+4xG5HCiBode04/ZRvemeCIzr2laHEAhFA/
lba63MulTJUgtsr0VkDdJ0Tb2aPfxv2B/h9TsLu66oq94yW2Hk2yNXuclZw67ArMmrtyHmXg2kVD
lpBnBWK0BR2i99f32sxDDUGXjOotz5Pd1p0IB2jgJkaE84x2j65Hdx4rDkimpN3Lkimu35vJHL4/
6LVNtUXW7aOhuO7PC+gZVFPcVIsMYyjDjMbbX9lQt9/fH+XNi4uZha5AcRg4LxJob9psVe3ie5Lp
EZK6+V1Fm+VgD/10MpVBP9AldwCnKc1jm+AVUgzLWod95rlf3v8VVyYYbUuTKd6UqEDavt5hulW5
+lp6WjRDhzMThAWM3gw6gSFogCvALGDi0YFK9KAeK87IjZvzyu5y/hM6oH0NIW//usqQORjtXjUj
OSXJQ1a62qekHpxjWstiCJZ1Lv/BDFPZKJq36spXQhU1ha08T1TcFuL1l3Of1P0iWjPKMqOvz5mE
chD0Qve+Gf2MEcyhxcFGT26Ekiux2KHECSifVPetUjpGB5466YMZzZAuDjGKTR911sZ3Y+MPdVWo
oW2ScLxlcMtCYmCPwUBlK2mmptEjBXXl+oh4/WSHY5c0pgVEdiyrIOVBYT1NplJlL20yVpdqarxb
2iBXTpPDMYVvSQxDyHA3z6VbdmRHnh7x0EDofsjM4uA6DUqe7+/kK+vpgf1CWYVjixqb/no93WXC
tRc8fjTgrvhvTUEKZyar7Q9J72JdkI79jSLFlaNDKkK10qWhxgfsPmx1V+KgXmEPgRnwzwLlqIeu
Xz9kY+OewAdP92uOd+CffyTnZXPV2QbeI5ZQupUWnHEjKnrb2wqAJoghUK2aJc0DD+NbMO5rk7pp
tLGDeIBT/3g9qTmOuSaFFpzBczMLndicg0ztqqA1yuJEAiMv73/flXhAcWPjOMAlQYRr+z2/JWCC
myCXa2NHRTzqde0PWuLN39N0ceXBcXNtTs4xShwd9PcCG5TjVKjlLZjmlcBMyR6EFAwryt5A9l//
iEE4dZNiaBW5rek2TaCVWtp8nkrpkGJ0uFPeW3k+jvph8PIq/wT0Y5FN0Os10iRFPItb6e/bSeHZ
ZG5icpAkyYB3kzJ7jSOWurWjivJ4cUjqXt4huzsGiWGKD7hTDB/cXmALblT/i+ufsf/jmvBI3eQ8
Xs/FLFdkxdhc0VSgdRxwl7jCT2QtnEBR62a8n9whGwPKb5uHLGj1f97fEG/jJZsdPTtuJjrXuP+9
Hn/Vh1rL0GyIxmysTX+tyuk0liuK+K1qFDcu/u0f+736AhiAweBlblBWEBHbj/lt9w25zk1oVlbk
4BZzcPO0Ogp8b87G1L+QgMRfPPzVniojrU6rHPNbHmRXh2eOKXdufKp9ozqTWQM3sjcjxlvuwZQp
flta8ccp1ZawWeLmMZU0AsLJQaIAIyVewDfSrauzjVftNgtE6n1jyevMzHEgcEfSKstP8Kw/9vpU
XzIsyG8c9GsjYWNH5gP4hOx9t6e7tc5bO3XNSGnTc5HY8d9JZmIYN87pH/aPt0XlmWWBaAKGAKDp
9aJy3baVYnQWYBOEr541D4z3dKTvX87PZSqTKQ277dYHkanCcJpl+eXPtzBJBu9JCGuAhnZHKDNE
XlitbUVinYyoK/r5I04h0k9b55Y++9u7duvWgcneWH9w+7e//7aBxSIMWY+eFSlJb2P8QkKfIc9k
VF/f/6RtdfYHhbSCqxZuL0u4P5WKOTRm0zoR7+X0qLnzh7GP4VCLWDX8Ol5vFbKu7RZqZ0jBEv4o
tuwOZtJwF7aS8WJzxLi17w1eQ5gpVWd7rP7MtoFMkA1DsYxGCMS3TQDk9SQqbePgWeQ4ES0++4ud
eFMXeasty1/IwpndTx052NHv4qE2bxyKa9NKgEHSbGuFU+p/PbI7yMlSRWxHHZIvue9aeBU3cPID
BX9Q4Wu1+OvP15FUifhKn5Mzst08v+2Xzmh1t05cOzKhLg9nF5mQzjeHInkau9JDrgTRqhtp2vYN
+60DJoiDSNoNIGm3lGOLTd+4KDYZf9M+t2M1nlOntZ8sPBrOa5aofVC4WfXnz1jAXih+oGBPVvFG
wZ+4KaqhZAc5nQm6AFwjD9ZOFPc5pOZQs4YFSYlYWV9mqZY3PvnKsmpEVGIqwvkkUrsyLMKeipGl
mRtVsSID/OCUQwaj+Ti1m5ybY1Q3ttGV0wIBArVyb9NNe5P4S12te01lPIq61gWInXs/yrr8MSEf
e6O6e+3TgOpD2t5m9k1115l5xJrtQmXObowD7mnqAciMidStNsIPQkL5jzcscMWNd/8fM3WP/EUZ
LbYRcWIqh7G9zJPiPa522fy1qkv/iILSLWD3tamklozZIcqU7Nnt+387IJkzOrGmLDYQyaoK+3ng
NsZR5PNsbIre73/bm1Yj6R13FHc/TeeNFrs7GljgND3SiV4Uj62FV2WmfCrdfD30Vbscc6uDbqwY
gijrLGOoFdSkaPtb2leKsrdMZN6mnPyUrePH9uHS3END7Ywcmz6Ix3WlZAH0ofRrtVjo+qzZUFxs
bTG+mGab1McuFtXPG/Ow3civQ8RGywJHb2x2MgifvZ50vXMTHadALypWXYUkW+EGPjle/7NXM/z5
ZrMcL6ZXygMKk4r0LfwHaIN5g1mEizm6X6surZ4cxb11jmn87/pz6K+RDPM02c4WPav9eyhpGxzH
OmU81JoOuqe2hDACymPDEOB2WRq+XcZqEY7L4nzoLB76PuYcM91DWSs92s9TV4WWgmOiwwQYB5mC
Awg8pKjmwChqqwttrTPvYmHgy7haWW4EaIPFX1MFT5UQ5siyftn6PGckfhQlmKw4N5YgJ3GdhyDP
PVuaQWnqhSaDOZagqfxpLTFmxgB6zOJHWZbgPtPRMOEe29VcaQ/I106e6neJ4ylnMzcNZQlifBTm
KXALBbkOf3a7bvpnrLf5PdvLOCm2Hw/lNH0yzS7JHuZscuUxXbnPvlNVqJenJqur7GI0puJ9s6bU
cc8xVozN4vdEf230vXbEtKaG2NdBxcTSsrzDe2CUPr6mdnKxVVQkg350Y+3ZclvgqqKRY4PQdDJj
9GlBqmq+teBCDKgcYv1HZupSSF9DqLy5LJ0O8cpb3C479cnUlveL24zmU5pgbRotwG2zk272hYs3
h146qw9PucTt0lOLSwVddP4MKgOBvUoruvige4ttfutFt4hz5lLlPRgyRoUSa07LOipdH7uHoTS0
MqDzg5RVZyd6/2HChm39FVNLMh6UydLmBzi8BZbanrWU3aMyw4vzUZm3i2dp2+n6y1I6gRZZnmfp
wyDx1TzOQlGHD05SFetJ2A5bTa/djQqllTAAIlBpiPFewK6uXtAVxex+G+qknv+hoz1rtk/AFsNd
YQ9l//eKWGrdhNMwLbiLT5ClzaBuhceh0oy1LQrfTaskLX3HaLG4DGbaa4nrZzWEq8+6HGLaOdyM
Q/3gFUsTh0nKi2/wEQtKlNz3lNR071e7orOGO/kwnbHJmPnf1iKrmyygGWSnGQK+g9M9oKdDvTho
bJR4tDDDInw9z7SyCo2P4Mg/JsbWaw+8AWp6GpAnZO1XaGBteafNK5ZWVMplWxy8QhnNk4OUzwRD
2cjTGYNI03OHydeWdkonCL4riLiw7DifpV/1cWPfVZ4DE3ilP1JfhBS994xdj4F7iya1InvEMSrp
fyXxKrJgVvO81w4p3pN9H0xrD97H9FpbfLOVWCEmedPEFAcIe6XZFGh1SqsulNaqVQcrx9wVWWjg
pP4sFc/5qWDivuEKtfqhG5e89mNNDJ6/cYXKL6JXZnnAOrNvHjyeuNS2y64RXyjHuAraPPHQHNeW
vp4eGHpq648O3c01jMfe1O+lZbfWZXEdXlFhUYMdOelLXLY/YgRi47uqtN31ZSrGdk4DZeml5ufT
KpJfTdZJED2qFmceqWzeqqsaYB9v9ye48xWAJ2xGFfzl1lWNCVOuTJpzrraOvMDryouHWe315bm3
ln4T2UmS2IvmLrFWv0QCy/wlar1PVl9F5C33M6RyNizp6Kjxr9gsleWn0dRN90VL0rm568SQio8J
SnDqxqNJlB8OBSeTkntJ4bv1VtN7jjtVqncpdMg1yhW71/VLWi9OjM5tTd8g1JPBASRaWjZQiRZz
MftHarRK8ncmx84CHETX8pDqMpcn0TRqe9TlqCd3LG7X/N2gE9E92LOlgKzDMwx1dL+J03T6SyaV
wMLDkG6OjbG0xvGM8ZW73TDuoP1NaV/FGLCbPXX5iCko/5Phogx67vTFdo6CQl3y1PStHB+RRVbG
i9og/P6FDeLYgTHNrQzszuyb02jjvXtO9VFNz8vQaMVdXnXz+BcOp06+Rt2Q0HWyx0LLL8NQT3GU
LVkzEqQahV6QnnSZ9nMEu9Bfcret5HEe1Hj+WTXcJYELDglNPbt2h3E9GEmXz+v9hD9q/2X1UBYb
grg1oV2oSWqqP+B0NtZdlS7LMhyLuUzGb7rRod0wuVwK6KtbcSlPXmN7Te9TdIYuncKWGJygWfO8
DvJ4mho0dJa2/YSqRd1/AySnLvXBlnHf/pgXtg+XxdxXDu8boEvNk65l1nIRmDdOj46dUtYcRRnH
Z1q+c4Vj3pDY9aVUZaZcGNuxX9ZpmbLPacKpvqg8Tudzo+gZ+HDLqpfML0wvux8HjMJ4lPZu8dPC
GHqKJC2QMg/NQSzWF4r/ovi2FM1k6yEXwRKfSwuUQs19KXrtJFprkZO/UM62sZADLfGR8rKJIbFR
1ZQlu8Zq7MYHocZDxWvBCD4vlLSrQ5W7YA780ipr19cmTESe84YE+qHNy7U8iNFV0BkFaYwOVglf
WgkqxbV76Q8zGagvUQWpz+kiOy6LFthtwNrq6GeUmWmfE9wmVl8KwKORV6l1ehDKUqffLbv2ljvD
njtzOsxG6eCJXGJw/V32o5J9TEZPlwcbynVn4BjuxJ4/9wN0IB87tUZvQ5VzWj065pR+lipI33u5
mrFyGtcqy9IDSN/MafwVB7v1p+inpvi371qVX1hT5Pael6Rr1y91npoCOWwey2uwmGVM2jjj2zw9
GrL35qd18IzlWPSSxtJfBpDV1gy4J+f4JTY1A1sCpR1AlvVzeqogFeqPCTYWdUTbDHZqCGEjzgJP
22akADz5i6hUzYehLosQUQIYlYu+dp1frfhvPeetwlJhI1lh1MVEWT7KPda/RSqyF6fr0pGb20Dz
RcqxJzVLZhlh+Rz/3WY9DXilIW04LKmjNAFKhNZ3K3fd7LFpKlecit7tqpOsBLm3ioAFJOVEb4+w
Mq3yKJtYpxTaNqnHb8UR/HHqYsthtE51ca3rY81vxmH8lbkSeSsXy+IfCDIlXzBRVkE0Js64eWrI
4sUwkth6mgu8dg7gPySSOGJQa+8EU8UUR7k4rbyfRdklZ02RgDbbjGv0riyq6WU2sIN+bltX8b7H
ldAyrNEn+6NJ7Vj5qGCtNf3dlqX9gtjlaAS2FcfPy2qxnLMxWhoutqX8JWCvCSxXG/MFYTrjudPW
1fS9SvfaaJlqES4bi+ei1iqyGo0zD3lYaoNNEtyaFqmdnlArXpJFq09E28Q6N3o/mz6Uhv6loQGA
M7LBNP3T1WbbBY62rEvo2rFMwtps0hf8n6Yq0BylfMnqtvklXHeIT9jl1MuPtXSM4teybg5jSGTb
7Oa00dQ5tC2AP3gC0bT8QYIpvQ+KaOvpy6D31gBoN5nL84rmTRWopZKX9+RJDUXsXpDMdFzmLal6
3DofuN4y9W6iL2mGnruY0u+62VUR75Laitdrkjv/xsC2eJd5vAxPCbCV5tTmZMvBtNSxAA4wmvJZ
7+ge3kutmaZvpkLHym9qFJQPduIm3lnU9AtIolbsQXNpJ9hW4OZms30sY3YOQMydO3NekAvzNMLg
/ThKNTtpZqLYGemdZ+PePlrqx0IU8z+5WpUjunqW+UkYCs4NXGGmjoLwOC5Pa7xoWM5MJmlCRXxb
vCxcUSZoAqtoWxGKZRzTOzrLJQ7ordZngeImTnOuIYd737k+S+uQc0spJ/po8xr7q6p2SjjVsLlo
U7tldRKG28ePaYdN9lfhdE51mBBKN075ZKp1sKSW1R2RnMmmh37pJM2kpurrnxRMZHFQHMEVlxiE
s+9tvtb6ZYP/ZZALptk7J8Zk1F8Nc7RPbdx0oH5KA1sIvxSzSA8eEp3TMy8LZwqNQbg5KM1WWy96
A+uTh+IYC4Evc+3mCcfayJ07IggoV9/q3M4OctFKRPUXbwztySsbZlQfaHvrcxmHZlFMTgBPLm1P
+C+BODbdRJRfa4gH47FUjWYNHTnLJRRuHY/+4olcvcwrD/uDXnRNEeaNgEtoCCtZPq1T56jfEOxD
5bGqraJSOUKkWMmZd9UyD59WCqhgKABnexOo3l4bSulj95YUWWTFs6O1z24MBp5s0zbT3Lzo1aw+
1piVq3ezWtReaNi81nhjxZDCAtOcPet+Bv9n+5lo1zSQcTcmhB+B1fmW/UwPGeSF+LEDHJD83Wlt
XYXABIG3Spk6A8aeXrIGszFg8eWiU/1JODb4PT7JUUIB3OunC0Cew9cpxrfFNLL5orVxQaNGTyfj
oiVy6O4abIztIHUXUfmZ2nsv+D1ZnwU/9YdFMqv6czsWg1/JpXEhlWhLceAYG10g+Bj3Z1E5Kiq5
kn4LfNJi9Yu+EcbFWAvzA44kCUWSXvPay1IpbX1qtcqwkRwuFxdl4bof/GxWEi+MXbw6Q2VeZjeo
m3p8kptH4UFLZ1ANRR7rQyRqcyEgQPBCA1yx83DRjC71a1tRrfOciQS7gboxv1Ht8LJjjQGoESRl
U7VBizBOc8jXBvyW4aaO6c+eSCu/ckt7OelKyT23lrBc+37z+zX1wf3XG/vke5UiKuk7Zmr/q3Ze
8hfzupbBlCMkZXhdo/GneHmwlA2VoBbW6JB0eLlyaLzNYkFvEusb9A/r33TG7DNIDdkuge2N5Q/h
FPBTmow4EAIYr3n+NHmFPGSuSmxpa9DDulFkFmhPqinhYGak+46XmJpvoJTwlzUrE+YnNJhnv0Wf
4pPd8TrxsTm388MsCkcBHecUIpjgfsKYnaRoQkUZeoVg6sgP1VR2XhBTwbhXUP+U/lhKDS+L/8fR
eS3HjWNh+IlYxRxuGbpbOVmy7BuW7ZGYQYIEGPD0+/XeTG3V7NhSNwmc80f/qMSNYcq0Um85dM0v
eJSaOs15aAhf1cLJGraTOtvGOYlS6izrJ57xY05DqXeKs1hCnsKuvsrNy2BfT1jjifVnMFD3TtTi
nd19bT6x8bL4baU0wAOSFrW0IuTjh3bbccy2yO/+sZ+NeHyt+Zgv+/Xlu1/l3JL8LJtmTcs1wQec
HIvzHHumI9zATtZny/c7nTfHEVL9jVTqfiNL5gHLRM+2ygm5cfou07e7tKFdlLPuJ4KRrPGsBg7p
HKVUu2RR19vclnt5jSyu2ItTa09gTU0ihEqXcHa/rUZ4Q+YshKBkPGX9nK3dqF59fjKnQOdV1YWy
j93kdXMQiNeBWkSU4OrhxyTcfUvjnUJYXgEm+rwKG+ffQFsAzbMjXQV5C+jIz1K1IXczIqpn7e1t
k4nQqv+MrhIUQ4cdcfJstCjdA91vOSOlqk6G7eQBmRUIKF3zARvdjtuhIHoqXDkzOuwicaTCnxt1
tLcqxjDF4huqDzhyEaQ0x3sux7PxdpLubLSVW4sssNwXgsaSRfEFt0vMhBObmqXAoRGj5DO+jnDu
Xvl1Pqrwv8i6GkwH92gyt4vk17QdvDe289HVS3xdbYO/E72tv/cu3vJkxrSV2aVoH/UK2sJpUsY/
ZHVcG0q8kBu3Ru1DSwSaG0CQ0XifilOzx0YRTOzlgAcXXjPh4YuWzpAu27J7aetJP8qFa46KP3sb
CqKVJjz6HjlzKaKlessdU1F33ezcE+myO4RDW/Pgc36KI2QIjaIxuIrpwy0tZbfiIq2cVabR1LoV
8X/jMOSOiO3HsFmUze1suzJFLp24WRW2yX++NzYyrTn4Phu3JnIypJhGpNG8ji8MQJTiRt5AKfIR
jlg0XcaB7QXhYok44NrCLXlzZeYprxfkSB8WU880yS2Lmn73n8ISNS+fCHHMePOBuJyBYkeqZUXz
l5HBxXUjtfXfNi5dUOz9HL4JbuUhG3VNlR3xuvW33aqRcpjdOX4P7qjHfNCsbamqcaVlhqzS5Q3R
cjU8cb3sy+Noe/I2WsPmrWnnWKdj7bQPmltanEyMxPe2V5IfUujIGWEWdDkVlRjKbxNtqs1aKr4C
pnsP1tFnkL90oIlR1vWN6VLs3GGZ8myZMRtAJOoTUrZ+PPkAT8cJAJGtZQx7O53kYrjYx7WsuTKt
TmVVgAO3YLqY27sejLkpbNiU5Ie9mhJgM9x6NsWh/Tw2q4kLSVolS/+k6LxziUB/CRvLt29c3pgt
w9Yq9L/eslFFjwTf63tHAu/flBr/waVs6FW8SRgGprxkLHqbPNOCu5CxhMBCuBJEmDVZZfIgfTwr
J9d/OGDSnXQXJDSgs6ap81ztS3jkx6pr/i8q8qsbhpHdzuLBIonU9si3yCBL4Zkckq/ry7ST75bF
TYBHR9U+/7bX2zqdem87hgfLMkLlK8NDxYwwtPbFbhEANvMUdufRVm0LBYLeKLuaEJOMlXxtUsj1
ejkPUtNsL5J5Cz6joI3WU7QACGW90u2Qgocq9W9q9gAywWL5zNoqjoZcxAEJmKmJRRPzANgjjW2m
+v/UpM0Pw1LTvcTG3T5cJr2JsqWQv0ooVS8P9f9rr0WlrTcFxOumcqaBCPZpHaMxW43lYMQay/Db
dycuOEF2y5DKJmEHFjTa8t4j67GKjbWI0i93cW+mREl5FkguPir0lkO2VpixpRuM5lQGev6YOyqQ
0oMnrc17Fr6B5BDInIKbHszQG5c6KvxoiJ4GKwKwCeqNItEu7DntOO6nIkoaq8ugFY5XV1rxp11Z
cXsbV0Y7z66UA/ONO9ZVga14mVNuFek9XGFbmbvNYcxNhBjrtcGvseTbUiMX7QZeypNj1jLMeKX1
liU1y+8NBpTyWdqqkoWeAueVOzep8nKwxeey6UCm5hq6ctfYOvAL4FV2n2TzvNceuLRJJ0dYf7tI
SJGiyw1KnM96Ao9oKv5lNdWul+nQlzd+iz8+q/xBf/PdW19aY9xOO+aBb9Iq2W7E2JJMa8/+Dg8h
q+aa+gSJcEravmoLRUJiVbRiG+Osj5b+3+iZaSkm8kq4f82xPo4q8P76180nXQz7w5ltYKAgBl/1
rYhZtvMjph8136ZV/2qGMfwTwgV+l04z/qkSizy/srQoAbSN7+4FlwtTVbsMoGHLQJzKfRcMNGlN
6zLmHYAAvzNrXToF3fHUr8s8ZKo9ghe+2+jgZfbFhy+jsSOvpL7m0tZr8DGw7ThZPBntM76Gkc74
2YbxVDFlAxwuMddXScSGSCkIqvdCc0I/XN/Kd+KryjmLcZoNRQmXYU4hSM+b3KNrxkGwvc/x3ux5
0w1GXg53129oWESd+7Myz3LhhitiMWpz14AKHwV7Fl9XQ/xCkg2rBQ3kNp2o+NhXv81CcgzmTJXS
27IJjEQUM51XKk00KrI02PuaXS3uDJ9zLcImM4o6o0FfpV4Ds+/Ol0pHJFjB0kR5NMs4b+lSmSC7
qvgEmOBWJ99e9n8Od3pYVMdQ3ayEfHW52GFHIOUWEm22sgb+aP2xPmlf8AkKUmfHdJRN/abHEFCd
Z1d8js6+Mytt4dZlAxGNU6r0KJ6NbKTMpWu179DsdpPBcJuvcmUzyqu+nymr7Zr4bR+ljM7UXJW/
k9HqbzdrVvq+YmW6aYJ6CRnvne29DTblZi2qih1uiU6AHE9Ru51VU7c3nZFRcorLLjJZAHVksdqp
+hawZVNpAG17K3304ak7m3nLVnup7xCUdHPWh+61nYeL5pZ1WBIVEM2eyodlGmQ2H4hNMjlP9RV2
o8wR/wDAJhjqOkLjdpXGTytN9b4QsySLAOKJeYxJrM27ylJvzNPjmq7eSinKVnfummpPm2+vjLEH
d+5oHvjFTf0QBFa93TbHyq7vDkH1JyZFyUrnFRQ683mkHuIRXWqmE3f8NR0xEHrc7GWctrLXn2Y+
LBothliWmQacOE4VxrkPe8ffaUPL/Srr0Hr3K7v8Q1XFEjP3dIDVh2FJ3MBfuxR38Gjfzl41bpnr
1MGdx0y6ZjCO4t3MVfm9cwIfKVt09+TjIfVSgP9Rp3uL/jGrbMf61e4WVYVdwgqYIaE2bWElnoDg
82hbT4dSxH1GAvhVnNfRMJJ2U0JC0RryIObbioOw8JVpGPWOKSBoXU9k64xJFVFgZSK95LEXwyZK
g5GAv3beoEasQAwpdie55tscsAvYc314t4GWlpOtegEimvxVPEfednXb7krGKSFgw3/tngj0SOWw
f0brtFWnI0isNQcwWssbq5qF+2ghHO1PVQjay3XdRPfEWm8uGM7QfDqaBEIGX3ccgAvYE9Nxl8d6
cvzewdYV2tyU0+rwbkTykMydx9789CYev1NU10qmoxH1VyxjY6C8VMMfW0W1n1vwpfz3g7vFl4aN
Jj7poAZC253GOyd+3ddnq4ddOM+TmNZHhZM0Sl2xgQJCfKzsyTOTbIFrSMYZ02zbsL9xRp/QfJXb
pXSUlswhrvOj3aPanAGvGWSXgU6PPCJ5Zn9qMAPz5vQDuO31QX/F5TSLYu232eGSqOq+54WXtQUU
mJhtozU13KZzoxa3GGpfqtM4aV9mh46nLgVBSOxL6PfBT85UHs4YIICnr6f5PPVCTXOeMAwlWNLn
427qZgVEuVnqSC0gqyZV0HwA9VW70xJZqTjJNjukhdZta+bHhGW5T0uREJk3Ak3/dHlby3yf3fD6
heikpbNn55+ycrrboV2SNzNavM7I3YAfV2Gu5i1/b/8ccDhMNQLJQlFXh+tcWmc+DFNdUP7xhoRI
WW/vtcntyKpvI7Jzfqq6RsFMpAV7AsqSpC/acFMTYz1yCzRuNvHZ3bo2Vga1EHxgzG3XjOiCzuRa
u/6nkNVONI304gfiFRncbWeb7yEwxuoMa+gMt3EUlN2DNRxL9QOHmbQuCE248h3jr0s6Tc7xK2m0
hBQbiFu4C2TTqp88EYubzoHq+8eWyQFwvnS3NhNxuML4eYPXFk090Q/Oi7XGp2orYbmswHtN5rJ2
i30XFByJLmxsgp2rkQGdwI7o4SquIw8ZAGb44DWshy4tk809HnrhtMPbxp3/UVbucLwR/sdHTqBV
PBRQvONff/aW4cSPtdcY8khLf1oUbr5fNPEp+VAi6dbnza2XIl6Z7i+jGLgSJ0OlNIWRfvh7Hz1F
CDQQV3sZyUv3LvY2CfvNR79g8uMY/KVY4nDmUCbw5eAYVObFpuP6uKADgjhKjTPXwVkAXDmpFDA6
98cE8pD6jKzqZRx2/tkBfRuWckKbghsXSj367CPEKLiVknV/nnbFF7rL2FUApm0wvrVLbdENvnqy
vVtbNprT5FlR8mzWcLVO9F+tU0EG4jDe1bFt5tRz4VAvgRH2CtfsNSobBd1O93XT43i9fkjbnUhM
EP7YCJrfHx2esIpZBjYveDPBsjlBgexxli19eyzGDJNmGB66fTr+iWPg3lq5di5z7JYfG7gTtqN1
hwzzeh1HqdTzvOZlV81/9QrvV0COdb8N4qC6oAilT/I1PAReY1X3j2sQHsNNZWmdAQetmbTrFxbq
mTOte+K++SjDuMyScJ7/9puebzjRgs8mwiuel9PW/Db47axHZ/NZdhfU/7wx8Z+OmNuPaAt+diR0
EBzWT+/VGl8LGFjpvUFzcOV+N4pzM1f9h6N2PzzZU6+ACur9dwQwmnBX9aX+r/ec7jG0Z8C8jgmE
XlEpjXWrkyYeMzQ59Zq2FCCIVK1B8mW0gqvASd5cKhkkj8gtAK7Ksor+Sc+vfGoSAA1ex+ig9qZm
Wtvzoa06ghPtLkyDtQndSxW45gxr7t2Bd4Hr+ePweu2XPoFvxCK1mnr957tkky9oIzhvfBpd5nhq
19MmRkWpRpO45qkdCPypA+JBCih/UdhBTaAa1jGqr9lKYHKiNvjTihoYINbX46WqjvIvPPb0J26P
J0Tmicg7OuOAvGdaUNLVxVpHN6dAXYZHOirmSgGOLk156Nxsaj0vaIPmLFT2oM5uzx2V0tDU2DmP
TjKmnK5zzyDJaqF2Q/cv+QYsC9sw6Ze13OinbXD3sjQl3W8GhOERlavNChbOwWXmmfTYxrSHLnOq
uvjU9039TdZWuGU129wvinkTh/UsPv6NFSrPbCun5iuq+VKCwNTqBa9plCKd62rYNy0e22CP+hM1
1rP3KY9YfG3T3gE22wpkOlL18ZPc24r1wFwBoMCxabQZkjn5PJAAeY+Ua66ftZm1AGkcdutS9rpv
UebMycaxgnwlNYG1RfkgLd7+WLkQhjNK4rNXmqg8STtq5gdp9VsI4F4HX3U82v8hh62WFIjdtl8P
piKsOx69029Hb2ObHOI1/rJMyZtT7m1XCLEv9TnYIqjXmSHsHk1Vd4vIyiHrpELO4fNdWRAZ+1Ko
oBunVx5BFsBp2Dv63pW9bFkTtnIuNoZfmWNIGtWXmmq9IsZxuWwszn/n4uBhAtKUgGy5B12y3h/z
Lh3+OpkgHeeCrs5NG3s14PBGW13dimA51U5AxzkKIZGIrEcD0uVl5NCI0Cc7I/xsQn6qsLz2kkQ2
qX46OXx2bXaO6WqoXpbc1N1kZU7rTD/DHhVNujW+JltEmjZOV12VqBsSD3TUI+QiYbjxuQxiq46W
dEbnjxpsC+ntqWYn2dN9moIvS61ieTysleHON2Q8okWhP7QjVPSfZ2k1Zos/7yq3TIV+ZosRrOaH
UL2Vlkc76dveGMqxrpsB4JfNUxRuIO4pt65fFurg9kqTPWoAZyYjC2gHpB+JaqnydHzdMDhaACmZ
0CGSlxZ5EYv0IaEypn6p59uQ0r/wEuH3U3TTzNVx01edXxcNv0xAS5ZPW19MD1qNLq+l/mxv+5ep
3uefLDQlC7dli9eqdIIb7hpl54nR9Oi6Rlyhet1bN/NgqiHFZT22RdnM4vWAx/3b7kfy6E/UUTHH
zM23YqQEcIaCHbNKw+gDdJvVvUSHx+yFvu2ptY/1y7aabk131HNeOshkuGvHVt1IgEbSVyC7rpOp
M6f20LtfLO0DokPPHX6M0dC1+SwduLduqXon7cLKjjInVvuvvh72G+57cxeB0ENu+nXV55xOL5Wx
+V9QJxt2asuJ8z7uD0KUt5oPPipt9GyhM25BCv1xJIWK/fnWbfvtwyfjPcjGshzJxdqOHiLMW8db
8kJ7nzxtS9Mmv8n22a22br1bNftSQ7ubSXHkkyzrhoPnpYfvzB+HO4anBYcPcgKXXMwTxT3mGnLV
tKwmllwiIJOu7FNlqDFL3b2Z3oO4Hb44D1GAdFVfP9uxXRfXq97ksfbi8itGE3iK4xKmtXUCOrkH
Wc4fJQkYsLEMxvE5SMqgz7tBcBZwkxMx6NYoiHhpep8LbT+4I3Z/3jSlCzhjUWNU22lFr3+fmJ37
BbS6XzKyik1ToPGAN7bGVfWvXeuIX/4AQpFtvjN4N53dq/4+GqsBVsvV03TkTe3WkGgILAu4H9Wf
F35P5KYqCIYUtEkICHwe4yKY62bK+1D68Atey9KwGzKsz5I1QjyqRNvbTQlYBEsq9VnKo31d9tju
ClVXbf/Wlx1eppYfl9lh4FecLOYRbiSsWBfVlKrjiyCr8pae5VFlgel88EULmcL9UrEq5dx/lXM2
5MWxbQebhWZhEC54Hz3B9qVDcM/uf5BWkymXqJxUtb3QeR8p9d/edVXJDx33fQHMj1RXs/z8DaOx
dnM44qDOkBJ6dtbbZfQnCHaCGHaY63yvJEb7sUvqUzSE0X3vb/M/PlXry56OaSokS6h98UQUQZ2h
oYSdKiuG0Kh1Z43EsB2Xv8ir2dgRj7sPY2TMj4XXacya0lrvDmbxvXBEa/8llXy7P8jaqs+bZcev
G0YT2vn6Xs+XUBum2WBQnZvxorQ9hl1iBjNvWAnFUshIQbJkOTIojEQ0sSCU0YcJDmAb5a5ecvGn
ciqfl96vmpsDRUeYRf66DSRWRZ7OrK4J3FNjTTYXgHa0zqUhFRfavE/s8xHS0ZvNTr88GqKCZNbR
QDnyhKLMD9LSjjbogjlJCGks9728bO6M5Em1IxvEFDOQdG3cejcsQdjYNG97kHFWbhYmduC/k+lb
75HUTxQijjs1Tm4vBnAVMFZHaRXs9sQsLvb6Z900sfXbsEBV5xFQrM94QsfVSWFfxHbDBRmsOSJV
8Lwd7VGUb/WIGtsnlyo66QjMM9u2INwuG1k/Az3PruHKRiZX8UxPXCdjONh/ElStX22g3J4foVyC
s8MSEl3/S+7m9uB1fINLbXU2W2XMfynpb0Qw49mvtEhuKJSxP7Wpb8Gt7NEyfLYl4rIHQm+r+uRt
Yv/ZdWpusq1pQ+/ks5tB0wjB+6L1vHMEJFHn3CwW9/W5a8jLvffBvqwT+1ekUhc6KzozY4FitoB4
9gX/imXlclvnO09pKhkEFdZUwXV8vJYl/1v7MNTnuFGlzwTSdIYDx/Ln+3Dny8sG2awvakDOCS4U
zF6azFeJvQWtK05BadrqyfQQ/3moPV+fQu6I6NuNpugDO2y5n3Y4zOi2TeLlr8d7Df4xuCByU0i1
VWoD2JKRN1TIVcwshozhaX5wJru9ax3q9jpr3R6SqXYIFuBKeBzpIXhHI7mEhemxM6AKjBfvQaN9
2NibPe9linxTZbMkefS2lJv/I5hl8jT48uhyuP6Bpuo1EG8YAL3hrkL/sYIt1zb8WFxaF51IYJVw
H127iKAc2Wn89uPQlTLvQzuG3YUmxfYRO2hHiFuIIuZsde50jxcIrYtccUdchSKt5NrGpculHlZh
jsxzq1L6H31mXROwGEfegtXc8onlQJroDzBJSalA0XxzZLItq29tuuQ4R/iNjrxNzPwPWSxi4Bps
W0Ft+Oa04cMunKYubwmzVVOxenvzfiwhz9qVzXw9joq9HVL1qh+vamVnam2aX7sF7JuG3MMoXcvf
/bBE9xDV+wtalOM//FARHgNgbhAaVK4kl9TdMN6vjY/wRWyrX+gmaD/05ADDbNyEuY3q9kgnmJ1X
hDL6374inWQxaKNnL6zXMhU18WRXTH+609Ue3y71mPwYoYwf6XXpv5ZEs00txKbctrILnht3XZ/G
2aHndPISho5k3Z4kPxxA/xT0P1vJUG9UoPdUTbP/NRjeVHRb5Lx1VTDcDdLYzF1Y8HI/sfcHOdhQ
idwlQxCJnez0ITT/HA3wPq1Xdb4Khk8Vs/0cbc9c00N5uVVoZzL29+IKHBeNDuWp28V0Nk4kvqa9
925UGYQ3tK+K98VZnLvKXyxoVJ+VKBBTnScjVF+wuA8oKHXBHr29oD39rxbIasgsT1LRkkpk9Q6T
BalMKFmG0lz6OvmD9454j/bKP03ybEeTekIIF75fX+hz50LpWTs/9mb85iK8Sp1jEd9XEwC46x9+
ShAvBHMg+18oeZNHuN8TXb0voqfJmXCrq6ol8U/teix3FTkPwta/USh8DXpDiiCOuxGNYsq/3YGx
wv1+mZbxRzkTmpk1E0qc7b2ZLNYrkj51puJppXB7H8L3uEPeUATR4mWCXfMhqMMIkfik5v/C0FDY
3jl99GCWXt5sS7hUQL+zRAofj4hHmvURzzpPN5gBcm+6hJeTGddRF3XbHQTZTE6UhXEXfCrXWC8G
8+fHHOMKqcdqfhotUf23IRhntCLB4U84+PZPzULx25ot/4ewBucJNnt8tpd+uJWVtS25XXfeqeKu
uHco9y4SgOg7WH2mZH24w/eIzhKhDV2YaexPYaFRDsG/u8njoYKr0mhVBThr/9vp3OOg5dlpb3v4
4nOMSBrCjKz0j1Ac8R/FrX/rQpd+JwOKo+jRgSeRiPk1mDVzjjyhlNgfSKwU75WjmOJjKe+AyrCs
D5WZ3txS2X8CrCcFYwDk7SrB6xLj/rJmH62o6dxCL7P/HvOuXLptbaAzCHhlJH+ruLefHZrmeRnn
yP3bJFfXxR5UCP6C45Yzt4c9dMWC1j1paN4UW/SBjGu4Z0QeeaORpT87nd//5HKOoO5K99a2CPxE
BHGUI41yjX3et7i/swXSbIRDloBecYb9r+db9cseYszpm9Z6jES3v5p2dvfUWyQ1v5Pb/LbW0vvV
bLPccVzMxw3DmrXiHfHLN3IDhl87UT6ohh2/+Zrr0uPPr8oGaESu7m8AAfUaov5ErXKEPHP72PPn
tBDkz0jAqQBgxq6SG2fwLbDIxJXXY4TAmiOu8A2sG+9bNWKQmcTQFNsovQfUlNOdQh955yLgSFUk
zNNOZlidoc9zrDzYBErIuOao69kjC6DC8TmZugNGHwTxvayW5qWD9EZbals7cHM1Vr/1UQqN1woJ
kTLW+F+tFzqbQ3JC0lAFCUtD0NAp4bT1IZEM+mQHM0Y+GiwXCph3NV/SATeBXEGH6PmxeafJZNS5
I915bfKwJ3bgFnHosv6xzQ4bnmrj1vLCOOL4L56yG/eWPQyMyCSWpb/GQW52Crpmf3i1XEIU4wj6
fpUrOvhLJ6tt+DfXk2ifOL88777rj8Fm1YvLuWBjMUEWa6v7gQgy6JGldMIZChQmW5vLpZ8Ma5QI
HfKHzDRXdbYb0QUjv9bWubc4Pbrjhi1DIeG7tmli99nHeONO8EfU9OyZ1hC/zvLo1bsV1ijtMrj7
xpyaSJbRs4rL2H2oBnTRRRBU8Q12GPMfidbNkNXHoOtLzRYwPouBceGEImjf7VM9O0NsHkcrlNF0
Wtgw2uq8RKB0TRrLdVqx4CXT0bxJiSR35cZTJv4lIB1CliMIeGwN3nQcWBUCxMrL2ZtRcjS45gzd
n+MB31Cgjo2RLihTSlzCFvIJ+74fUS7SFQcNw0Y72q27TAi7IZRktiOv26vc28LaeRSwS/HFHRZV
8klC4Mh/HGwuAOpmpLOqG7ekZOPnsJjVOiM/a5RO4xUBr8fQXmqKrux4iY+F8jD2ZPsUxc1W/dBW
xGUca2ImH5HCzBocY/HsjjpPfAPvodNrcbNir4sgQpi1b31kAglr7L5tmV+5JWHlPWLMokHp193X
fqTKnN+7WWyYMzfeP/kuarT34bb/0Rhs7R/HzOn4e4nsYWcnOFrgvrRaqsH+RXa1S9KMYVrtXkKt
nPlxgsV1b7BOj+6ZxIwZebw/Q8jwDHQTbqi9H5rHcILHQwi52F7hQ9dE534shfoOQ9EtsDPIjt+w
MpTi5+hpB+55c11QEW+XzKhrMznN4z7gegUspxXGzRrcR+XZ7OEOs8ZixnXh2ZZi2B1QnOZVTLzR
nY1aozSYPGKvOVmu13iftWoi6wGW8+DrnRdrOR5LaK34B3YWXAW2qEfybc2YtM89euEI7aPwyktr
7KhMiYI/zM1w4Mp7WpJmKWH4I4+dwlj8pdTI75xIFyvWx47qyV6UcvPVm5AiAzeOQftEAQensIlt
dBQinAKAH0rH5vnJqkkOstLKkl2VEICv2iA48xsm0cWxow59MlZk3d/gXddQxtEMf56G21hVJDmx
Ngefdh9r54/fhiXWkE3hVCmwEk8lPCcWqGtWUDkn+jxWTD7FxI/oOnmvFl+dvYNaTO+GAz1mtNbN
DEAk3Mnzfk+2xTMSLZ3lWtlVJ8/Ea+HYkithWSVDK+6aYL8vV+DaFGurNeYl32ekkfxdEZDMs8SE
CAMcvnQ+Wnv05HOATKh9Kp0YMlyCTMzfmopzccuwGc14lGoE24iC/La6dVTirGcYCmX9QWlSzt+z
HIPlRrigtAXS3rrkoa0OedaR3oZ7ohWsBIi9TaaLkrtY7yxRlmXuRKhAs2TzPf83XlO/LQi937bn
FhGTdVqAAXGyCnzX6RHF4GLYj6Gta8EmDgRYSVNYlTuFPKUuMTu53dWbmzttz8N/ioG5q58MikoK
SG9r9+zbIJGN3k7cKS6swdxEjXVHN+0acwzQ3gCb3RGrzp0RClTtTDr71rPQCT3f+f6aTDCti2r9
XEa+dSggEnU4b9YO5wC1xCb+FhrcIShuHW994IFV9YX7INzet32gZA07A//+ygkjJthn3F53G9qg
9apFPtqMl12Ib0yAqj1VNNYHHHN4WUei6II2PB+SzPe8KqcpCi5lQHDt2yjH/3MKez3dQrj6nsEJ
YQP7FzFQsHxSUdu2vyenrXhXnVLYuKAj2513n2jG3Vj2mRiW9YAcxVw0zOeej+SYPkIFSP/LxrHi
HiCzvPfPYxwsffjulh6G5rSmSiHMnUbHDWtUJfv4VkyV+F45SpLM6tc2OQWVWhXy68nY5lzuXrfd
k0mOAdawRq3P0TFyeTcE0bxE2+qwBXndsGdbT44Pb8biucvfkah1B49iALMQnpqR2o8nnYxzN2TA
oFZ7HwWd5f+KzEh9J71EWpzEFFC/kE58iLWNPx3j3Y0M/aS8H6LQAYjoacHzb614XvvC48DkpEXM
mNwdoP7/4+jMtuPUgSj6RazFPLz23O3Z8ZgXlu0kTAIESALx9Xf3fctL4rgbpKo65+zqz/gVNKr1
4Hf93eDLprkkXLEoODMKR7/BOzBnPEzr7B3ijnHsSQQLyxFJxQRj8R44TdGfGExmjn8ynpWB9zoa
DtyfMgn68r1rQHcFmFDrJVYbxMZ1wsLEuqluY6YmxhJUK4xBi8ccYx8Zhgo+veM8qcsUZEyn9jML
mORtpzxiNkCRmmTaTkBRq6cuRZ3uNiJdepzG6IBiY52xyr5GKIFTwUTeKasSWiCQ7EM41uHs7yH0
x4F5SCPdrWdy1bL7JhWBysFvEThPkjXx9tZLcVCXO+kUNGntvOj8mbi2YsPAzKgi35AQxtXc+6yz
vhGkuRt0orWICiKiubMcR8rWP9EaD+oSqhz6hGNijUySDJn8tbplNn6UDl6CkHOtyeQFFUg5zCFR
xfqRzEeY09w0fE7lrkxnNE5qnSHeLkXaNEc6dBljeopa8SMgh5WPMZSL9h9WyaH8F8zXNZybScEj
x9aOg81SolXuQFxriEhukhwMdo5ftBEz2MoUbwQbRH3WeFP7hxgTQvkkPNJWh7UOk+4821pRA60g
n8Q5qKillk1ClpBgZ7pGLrox/rov0ykuJdh6iprHzJNszUFI5dQkxlVmzbGMXK/od7VBIDgR3kSJ
z6+L1m5c3cTdfmhH76/thGie8OZHk8GYyrt3aTFxXWqf6Sj1OSHgj15naf6DNV3PzkZobNS7AStY
ku7iXCby212afLUnWxSJfos6ABbdpvQhOW0KMCVAXRBymN6npmgi2L1RSpO1+Euc7Ia2MOYg0VuH
z3Zkwk4m0vWWd3wWpiNhwf3jvQT4ariZnLDqx10X4jm7l75Nkbqs5xZHFxoYFphQzg4DJK/JD9z+
HKyGiTkSVTo46IpGIXkehF9f3WLoogEqurv4Z89fxvqYUzDpU59Q49eUgHXjfK7MN7Czkq7J3kPd
Q2zYMpPM1bLRSViLP9T1BW5deLO0KhEibH5rA5UMYDmYsD6j++hgW2PYpuJCOO0eC1xX9q3A+AWk
wuG63vWpE4c/3C8DZyPJMtiqecUU25RgAKpNMET5cKiyyh/uCVs61T5VVoZ/8sRNzLQN3TacDzW4
rpqaBNPywn+wiMcvJlbs+Q1BXdVbzwkZA23I25HAtZHwMXcXlQNFQKfIGI5rFCS5qTOSvdF5N0XX
crmQr05iFpz2ka7q9qBGlZT/VM5xhk20WMT8Qug6tcfCB0WAQ10tBYRxCkTvmhwjzohDkJbE92TQ
fdu1y2d3J4WhltCj4QWJuQeSF0D3c32Lw4Ysd22upoAx0VV7qnrtYjxhuQaMBjU1gX0JFavqrvpE
LG8IE8N3cJLa1gtFJOmt38BExvE4RKTPTipbRK94kqWz/AIsgWx3kHZiGmMjQ7To2FH1lDsWofqe
PTgztuJjkxZ0uXzVc3RsIx1jocS95AekyaYlxxXf24J43Zz7Irrlc1/tvV7KQB5CZUz2TRKVE2vn
pkqxDKWofPsiWVj7iQUs/JSht3CLSRxF1W2tIyaAe7yl8BgiX3vljed3DrEvnvN6xDSiGDztWDMk
1ltVjv70Tvk5De/+TAibNb9cVfOtcB1inxRiybizmsi4OPO8d1O6s1RVZGlNwgXq0EIZlb64DQGL
9Dg4jS6wjOb1yi4p0QEJT2W2TIehmaz65QetmmccpXPZhSgOEsvmmZCX9qfTRNqvVnCKVt0/eAlv
dsdsf1p5hOUIeuEXxnunfFzpme3vBluK8xWBllu+m4Idi+eeg7VasZe6XvbFx9rbox1jTFBEJpe6
2LmtVAseuyGlj3ZNaNcfgGXkmyjWTOjzpiYZxnAUsLJygk2kFF0/z+FgnGED+SJ0MiRHrNnc3ly4
8XC7wiyexj0zxqTvMDVMJg52YbQgV59CSvH6lWUKPXZyLA7R8idbi9H+MAdw1Q9qXew/a3Kryb9S
N7P/112GyTQblNBQ+HcC+/Q87XO3M91xcKuJ93uaM5OkXFLFrKKdt/RwJLYJTk8iLcJVlTgKhvzA
GHyS7KfeMeyYSqSw/ntfGM/cwDQd1HPTyTS6Hwcn755HdNX6Y+jxcx3Kec3kvYsEF28CJ6xZukNr
X31FTPzzc4RnmnuEW9TbGfZeV1u3DNmm6KH7hK8rQ//42bXUrDBPgu76LyBs3y7GpsF49U1a1muN
XCGonH1gwvYmL9xVvEeRiLJngmyk9umTG7/beZIT+ZTldeydBsZa4T7pOYFuFM/FcIT2FGDvkS7U
4LRkIcXOLiTNL/A73PmKFljpQaJKm4VDyQ5h8IgZZw1PsRdnDD3h3WitjmOaYZZB655X4juRTaqL
4QGL4x3JgaQ9o0UN/gp4OmSco4u1cvYtik2kuHOxkA071nWUeL76KHXGbygxrdDbuUAapqofHEpR
OXvd4uxWxKv/W7WFEDIm35r05YbFj6xV2mDRDJy/c0A5IlkHGefLEe/kXN1HA3kbNlOvQXkoxFRE
JxVe08rAJ+gtLtOykuwind7rqyc1Jn59x7fmWrpir5X4AOZi8M/kr7vw0K1Oqyg+2pXof09sLb2j
Buu8R0NUzo57QvguIQFOVn2n6iHuDuWw6EhiH8nc+ItSvQQkRvaXlmxq426Lrs2uS3pQrZ1PGoho
4YnGsbRswxA/+7TDb1mA665Ib5j6NlvKqqM57xoVfDoMqMKnoeHAOpcLusZNhwGYZCB3loFP0nje
buritGSAWBddfdHIozWQopXDjL1pA4NtIDFDeVj5i9mTKWM7HicYV9PLiGvker71QRK/tZb2/S+4
hFS+6rgTJLhyf0nI3HXopm+kaFz4JTEG2jfTZ8F4GKou6z/xCVi6Z4p7t/qZpWvkE25Hh0KOXCKv
MZYL3zw5FnQx4plXrjs8lqJ9Slt99a14g0f5P6aamKSJxewkm6wf8iG+LXuBo34s8HIcVlUbfbTA
Xap9COoigswwYrq4bYqEwV0WLkv7qw9DmT3IZkVynJXmd51Tqjdvxwo2PX/MJR+vpPaJOHuPbc2c
6SIYiDf7iM8+y7bNUmThsUjS8XO6IgAIdmYW/4gJvPkr1Qp844UxHypTxLzJPVJPs/fvNpHE/37n
aVgxkMfsJ6n5fcSG+m2FSTBTseGYbSjsY2ycmNVy0oMYJKTzKYCZqhf0KNW9IhQjim56PZXzHfaD
eb3+YOam/ZwRN/E7xRi78rLOjg9eORZNsrdZ7zF5zlXAbhA8rARZTOcGJNkHX9l77s0eJcpRhDrw
WPbNZMgZZ2VIT1A30dRiGg7wDtQMtqr7PAsHZ0sKVI1fi51WecKs3VfboorBHqSUO9iLqmKGAMqy
GR1F6WZhII+6MmTpMt6FZSCy10X2GVbeUKZuuOH4Kgf6Dx9Cz4bZ2BIRgEkH/ssp0dJdRfAtfV07
8vXkK6ucY21feTWrk8aoV4TI+yFxSJVFhdetu97NRRreF55P5XFuwoF1y/HQ+1Y+YrzRZfRMYxWw
bppFqkn4UmduMJ+XUUCcnvl8JwLBNksYNNVVcICK5/pPou0q9RRZxt6vCmKC9+GmKJ+HHDyJuCFA
DMDVuKZP801cRnkMUCGR6f2sVdNemmrqyYUWVZhO1bG04czqwzEAtV/jy7Ul9tr+umQUQdyvW1r7
qBO1+t1nWvJhlJ53mdPMqR6IwUlawbGnlNl1JEG6o2MkqvAGRyLJvl1clKj/yHUldIIW60VJsqMZ
E9pWsgT5uO6RfRmfphj36cOcKg7HPSQnkz0w1G2rE6cNMhQDP8dPP3tJ1fthx8FnbMinh9mf9CEj
MaK/XviqHUu5vFli1PQN/EXmyuhAict/mdarPhsSp+Gu5p4a6m1VdAw0E7Yu+c8ix56ktklXF+un
AoABCY6lUD0mBZzeOY9WEHba7LMBYyluwLL2/D2IIKxyrWvS6XFFimLoj1Mlw3fmaECXiS1wmMOj
ENXJr5Rqy7sr7Gbci3G12Jcm2rDuoWEo4FZnfa3LKgoJkoDdThvVY0zCsBnrtLjEs6H3u5dzRkYB
m32k9D86YSKSW6Seq92qi2ux/BpnDxDYgSXqXndD12/dv+s0ZEPA7r6x9J2DHy6NZkOQ7vlE1xXh
YUdIN7dPQpZu+wzWJY3nc7IGoRQXoiaqvieVUx96mu/mLwN0JkxoVTjvFNlTECK+p1+8Oda0r1LN
PwupMO7LYp2fmUukydHt++pPWWBC3axLpIOEsas7Oe1m5fgKDo7O1veQl+JPbgA1sTIIqNiGljK4
acJlnP9R3nuPRdhVqJi6zLxdpMkokXoa/IdlYkZ1EE5eNmeHkdOhFbYMiGcu05Pxrl4O3Mom+e0x
U+3hi8yAZLAL4aacSSnXv0YQg919yS3cfBvCnK5HV56VhqGTPwXzK+dskgYbN+5j+zYaS4WxoVXy
xKFnNHf1ovp6vZ8koURiiutott7oTTQ+obl2BKgULFwmBISFthxwLPkLwXLM1njlDxNXPECMpJiS
Jy4e91uIEts3SZ/gMkdJ2R+xONOYG4BgPs9oT0e71Y1P7L0k+JUz7KnQ04PWrv4Ooa77a/wO6H2C
N+oFt06AuwHuqf8xtSl7NUSP2ewUaTk0lzrtAg/cedb6+26aan1bYV8cniJ2oAXvuG5V+F60ofYf
8pRhxo3DRtLxpsJpABtGxK0/vjPCDKMzVCxxkdOwMG+PuyzDcAPX9ZjlJeRcflmnOdcizxVO1KKP
g2/sed3obscaHNwZI05SH8pgJbAVe27m3E+VMEy7W0vHs0HnTde3sona+Q73ECSI+X88PGDt8jHE
HzpsUqGy9ZK1Tqw+HW7LVFEuMtRkqtKV/AwW3nganxuULYPvBH0OTcEMBU8g78pT4zJrZczYq6rq
GMJmbbLs+eKWrCUXgVUCTa8XbdZso3Bt8HwBYWNCijc378x7wMA0xHKWMr/3mskJbyijYvemwICn
bxwyUCHm0KZv9HsYRYNzcTOs+Yzfo8XH+pZNZjz5DPGjLycbgMCxMSGaz6ppiJrKrG8ecJouHRVX
kDR7LxopGKhrZk6VFA8XZBfQMQ1G9zjjnKo8/mW6GlzJdbuEcp+KbokPgil1+MsHfUhysCbVKneY
Q9QXTfMy71K6cFKk9Wx/LU5dq4P25wDEUoE/8t4f5rW/JjPiR7aHG7MXbVHM+wndsX6c8zkLdi43
enlvhb0mEOb6d0VI577Aj0gMz8PzvI9FZJ+HGmP1beCA4bpZOCIRtZrRvwgCTJTIFB2MyteEnNQT
QzoinHCa3OA4+MSlcZszMX8cgyY/C4488kgaa/wDd081bVIOsvR09byEGxgT0uNJSEmLhTqOSTVB
MlEPOGab4GcGKlEQFw3Z7+NgZ7UjSS4zTDiNAaSVA2TiUOAoGQEDqi5iJiapetlIMtWjnffs2mUj
QeHS7nMyziEU2m09usqAr3CcjPq69/5xngocSQPJuba7FBUO1vBIeqxEeWUatu6nxRYhY02//U4X
68tpu6RD/wnEk/Rwleg2vS43VE7GQ8oEg4gY6VaJm1GW5sLWRcGXnvtThg8y6pIYdHtfOv1pBc5i
nyB3EKGit57sqy3xFcOj6erQPvR9E/wbgqD/SxDUjY5ZlBb3QU6Jua8rTVXldvQotMq0hHjCJ/Yh
EwWr1EeEd9UcCoqtc1JUIKNV7gioE2sV8H8DpXCdWbexag45wu8zXviaxBbR4VvAgT2RcYza3oHf
I3gm39V9eZ7fVKeaL6c9iHGMmCnAZWSvLEWKc+EfXw61k6zVLxkt/+e4KMcuucsG2B2cAyRfmlZe
XOZKMWLFXP4EIjYvCSfcj+OHqb2tBpWM96p3h1d+oyn8LNpm0t9RyQiIobZqupNXmbE/l2JEGR16
WeR79GOgKEU2EUbwLAl4VJG+2UsQE/jOy6rVTz4+dntyGE3DL/FEU9zyaHXfLC8W8WEdq/xZMwoM
djKkut7D6sSxOOAL1YwLojLdwUjHT12wUgQLyzi5bvdlGxUVWx5uqqKK1nDY++xfaL6bToCSYrCV
T4JUdBf5tb9zUZVxpmeYKYmZDcLEJ1jEBdSNtKYsJEIgeZHsntVivdyixAztbjHMyH87VSiXsz/A
CXl03SK3VzYUG1Xxb0uRQGoYPArMdcDFuqndCQVukxG2q/e6qRxsZ8DgovsChfEv8zon+qPhmX6M
k1fVv9CBsX8kyM336IOQYtN19s9oZdzyxeBa58SUM/3D6ElcMgdOF1GMsJSk15PkqaAXrw/xNENk
IfTpAVuGB9xCDWD181aMwOugs5CgxjxLSOMhINrKGDAfKogDzYrCzr0q/a1B5R9eCYyOx5yht6XE
amBqgCaU7n0OLKc+91mEqzgPijW6DBmvPzq8lz4Urun6rVrQVy5MDI2gopLA+Uzv4W2UXDQ7sp1K
QiCw872PJdNse8BfHl6pNPk1047Jw8gD888BoXrFD/QAb3MMqe4ha/I2P5ZT6p5bKYbwlpElocqp
ubJeaK3Kl4aRD6Q/ugV/C3o1PVoERsb7kfCIfTvsLLwbumR4cNmILLbs/+r+zDw4aLKGld8xUzw2
RSCwO2wpaRFuN17VeTETESXVrumShsXFJpuSE5UAwqiZGxefGfIRy6zmdXzmNMDBu1bltOwAGK0Y
LFGeg+xo1bDedwk7qFU+h+IYXxXxGNEmOcaLnOC0ZgQCqpueHV1hcOj4opoTMkhBk0yv5e0HZ4qS
8ZJKxi7emyedSA17EoUlXgDiJe3vWcdefdtMZHaPVG2tYuNqnP+xKGw3ufZSeVRzDeMuIG3wUWIG
RyilZ36LgXnQ+lE+sRQj5p5wTos/KvVlBPmZI5Xm2u2KOuIoZCxPDrxoYp9XjNo5vCmgF7r7lUGX
/YJ/gqj/jQDZkZ9287YUYAZl7rIHlSxuWmCSGNIbl7+ZtC8ob5KbJhk4MrCGcIJXT562LXKmV1Ze
gYGoL/PFWszLRdG+iSlbT/3k6eJDuGsOTNGHimQO1Wi7kXgF9tydnmMoFJPvecHGD0x2D1dXoyYN
2EQOeG/RjBzHgSWUerxvWK9H1icRM21ISHN9rXjqF6U/qsUTC2igfml2AZiwbI/uD6t3nH2YOTwh
F5cM5ngyLKu8T22VLLuktYYNMqXRlffM7hHT/FmGYUBByFMJuQfCjBe845xi58HepzXqz/6YwJdS
XZ99Digv2Z6RHFPwSkhfn2SryIaneaEvpM+i9Ce1sB4+OONteQtpYtzBCLMpaopezhUfJYORNu2a
d/wZ1R+/idk0zS0aWfSHYX6gh1+6FwFp7t+kCf0RRpYC5oDPAsNNNXVT0+6GasZITCzIFrch/k/G
OfUM58Nv8eecfSjywE6q1orj3GRLdLD9KOyvymdDKEJqlsrLAM20xCDk58MxHduIeK1krLupV3y0
zIKhvjaMJFE0TnIuF0xYKUSJAv98fcCwQ7eZzIt4ip3Gyl2l/EYeltLXUFBEw91ZpNms7xZZy4vk
WSdglqzOsZXX7Xm6G9ynfKiddF8Hkb5dh9XD/L3yZt8I7KTEpPtBn+uA/P2u8HWD699WeEHz3EMC
3SQ49nAXqmS6XUie00GtznjbFQPBuc5QsL2MCPTl0Tc0MpvERnX0u1XErDYNA/8/XLHFYzoRuz+S
F6ufnNkJgR9cxSLmzuMyYmZCg3c2wDvQpmZviX4n8TWmwrNC5060EMTKQLx0Z72hfByhEvD3jSne
J7bHzTvCFJ74zZxdBxvcgOs9KCNVbJkeJZhMmdwB4xIRvvEs8UOcvIpc0cEjhS23qTXO73hy1IK1
wqOF0zUcN7L26nuxhpTWldGAIylmaRsr40iUtxW9ssdawNelTxTkDy/AawW7eP4dM1mtHkTtFpqc
sgPSkCOzHdVjP44+SXfCRvWxdGPqWO0YMghs8urQEVZ2i4zLRHZgycBHk7Frq+PYB1LfDVS6+jQ0
c/Ftag5hJqvu8lJYMwd7bVcYThXq3bBjIERNA0PbHbaCFTAncOGGaX1Z65esqKL40AbzrA9zPQ8/
ZUahfW2K1XNXO5EkEuqQsKN/CMDp4J2dCRCv4bvA2S/2TWODZrOUNQ9xKLj4N3Ty80dWyKTbia4L
6h2kB4PWJf302K19RQpQVrdtYcWrgjOBM7Lrmt+4CwtxIyHgvnk+8JwbmEXBEzq/eIOrs6Lm+cV0
SVOjiZVjxMH3ttqZBGW+rIG4x5+W/kVRLZJzCOttvuCv64f7LI66s54kRlIoEdkraWtQ6kaQpcZ5
VUt7H7YFufqqQYIrjamDPaKC3mMptITCBi0Y6bD1SV5ZXTmOXuhF2d/YmNbOh5B+3hxqGaE85D4U
7oNkQ0G+hTyRXZocI8uOcGIznxoTxGewiOrYCaNIHMxlhl17pji5J1DZuvuqtw5RbsnyChJwONF9
PLbHiuQ4Yy68dnR+q204e5rEjQ/QyNZXL699567sEauu4PORICJ4AF7gHEj2rKpP9FeXR9ZKkyX3
Iq5z5xlpCvUoXaJRXdx4CKbzMhRiPFS4v51N7WTZ72XI4U8IKj6Qu4tPBiuelsI9EYmk+806BJGX
oUkjRHdnSaIPEuZ1yu0xYZhwG1jNu0knXt7jG7f4mOLAJuiGa9J17U7m8LRBjRdKf3p+RruxyadS
vRqWgDH79dS408pJqmdxdQhvVJc5w0MzsjTqqATbCc/kQB17VLWbwAYzA8addWjoZ6eJ2cV2xWhH
48iCq/FWm7TrfiYwBw+zouu+zUdAsX1H48DktgyBg2/UVMfdLRN+aGLA7cyAa8Ll8J8tscddv671
UxMm4ifnd/w11TQ7BPv5IBlaGvMCFFSNDBzFiv6bWFD7kM6RB2SECTyQXcIovJBNt6uSNZWn2OLZ
4lhrMu8yJllyWSYbvEVp1d6zrxiajoel7a10fTBcYeLDJ2WIufyylE9AX0iVT3e4JtHMiwUHJ0l0
7fU7r3S65GudWY9xYd1gWh6riZ6cLpPZ8E4CrSM57IBChIXCcVMr8hhbP4Touklg4Lyi3fIF17bL
ORdKs6gD1aWAdhmZAJxx79QfUxTPr8DLmSFKOG9veCXy5pZdds70GRcJ2/FcU44HZhbCvQe7HN11
AXIDSmVV/1i36G7LUYz138kP3JGlLIylKfRTGKdJYRGtqIchVhpjFQrXHK7Dx5z2ivxKy/d2wq9f
vypWJTSvSq3DXYr6236lURgNj/ih5n8KVF+9Fd7q/aaakt0FMvXY4oWYm28ZOc1jO7kNBr3YBydn
GzfDre4pO9/5kUuAiI6GyYnK3HF8ysoIsTHh2761pq5+dJC7zrdLPpaUYjLa5MBjkdPL0H6Jnecn
hIGQCMPTMjEKOIO4MeHTikA8fNBpLP0/0EzRciPc0k+fErLywQ4X/9JcvL5Vf4yXufKo50z0NyyI
FCg5VYQ62c3YzjZDOiyG2Z2d3N3sxwyXNipy1uGXkGGbPeK/9Rd+Yuf+7ZsqCy9+lPouP9bo516J
fL5MVWsSYhCeNwF5xZv7SGsi8hdJJiHfGrzqy36ECfu84AbsURz0dM5qRu6/eqi87NYIdHRsugkI
OOU9lCUiCTXGiE9canF0l4LbrTYmxe/JFjE2LZyaDOMlabs6aw6Tm+IJy1BntiFw6D2kcVZw6ip0
gsdxZqvgbW59/KHQAPWyRQRjqtjO2fJU2oIlXlTuymxtUEWfzTJ6fbHtC6+dN63MW5zZEaw7LCpD
SbqHmgAM4pgHf8OeicGdi/HqHcpe7R5zdIkEcpCvnqOZO2oXl72/skxE1upPBBANpS9jMAOQlg97
3/I1462ZKo/Jyjr10a6qUZlvy4G5nh+1OvxI1KCD75Ti8zyxFYEpIFtpmp8gtMG0pc7piRbwQuCG
yFV2YdLg0dWvrbytFCsmd0ThctiqPU3VtmS7A6pmPY2fXeiVyPX9GEWkh5PhO2s6wBDjGo4VgpTC
8A/Dd/3j5AENBCzo8M/aktC4K2Zt0bjSJkcC6Olohkn7dGp0wv2GNR5Ua+B3MQ2YUTg0rZ2BSAd6
M+FZEqGYHtitwrwG3bZItlEzW+ilE3sdR2znI3SkhuUidFn9FTSIF+qEGyJnJqYxTHgVzD2UJxlP
W3bVdgMDHM9/pWCPwe8HHTSxpoHGEpSR3vjcSv88i6kcIu7Y/7AloGBTBR0FJ3HOmG7jmlw9kvTU
XN7cjyWwyHR+mXGZ/MB5h9CQVWa2dA4uTDA3MDidIxstJ4/aeMF1CXB4O8Bqeppwr2IVFHBTNgOG
oWAHB1J/ls0KR7RhcMV+lbCN67tqTcBlJNKBB+hEpv9YJ/T2q7soASg1t89itfrIEwOEB86B8zRg
mcmp1+rhEmSZS5QycvyOCasO/wWZy1TDCQJxqGzjfGOvx+QVjVn9oBfJGZeD75IMf8X4htECKGxS
s3uMUag/bRt5HRl7xByuERGYobssWPw36Zfur6k1fbdHj8Z/3ejW55swZvnDnKR9jQj/RWC4UGo2
fhtoNu4wOAFEBW2vBf0WR0RT2/WzbwbxvcZ+CUEUjYbleG1Iki1XKmdw18QxA3RGqxsvSNvncsa7
uhEzflt+NRP/WDiqJ7602G5LyB0D2beqcg5uGUv2gdur17ZtSvk4tNIvCHVWzBtwuimWmNgM+C4b
Ylex9ejOXnQXD4/cnAIoYcSBToaxY5F9jOn6rXXBalNE9uu7bmM8gLyZbblNTJw+VJ6hTqDR1oQh
fceKjfZ8PKLQNXsYOznBukNO2iXdssO59WgQagbgeP/lm5n89QtuQJ0Q0sQ8XaAXQpSPTPnv2h7D
qV/d5VeSNBEIN7xWVHF83pRsBaNP27HbI+y1Q7bNkk12WaPxMPjJAl8XRm+6ubotj+ya6TJytSOB
9pphSLWteZ/PMO3S4WIFavCmhGVBRrZMsbfOxFw+Z7+Z8cCDfX0yjY+sJLo8/REEaOGWxIR9D4mM
0zfPtszNBSXsMyNO/oiR9bq1ppp4MR2lZbJf+wS+xwRpb937aS6eqsIrv6S+0gbjBlmt49opt6Oc
eLog4OT3sdeSIaZ4QCvkg+AytnlGLZ0U2dJvl+raibRdR5Ek/Lgv9r0JJmZ+dTXgpWBX2CvmUsR2
IjDX+LXNxrPxcIbsFD6Dv87qFH9Z/zP6CPmpf87jdn03nIN6m00i+VgWZyzRnKrqlUDw/CHayE+J
foX6IQWQ5G77YIa3Z1xurU1FJ/srm7yc+W2s4QWhYNPzBzWOdeYQuBDJUjXRpU6m/j2zDLUuOR/e
Dy5C2CEA5Ojw16ZMLgku1uogeogIeACU3nc6Tx7iyDp6P0Vteeu3C0dysOR1CZ8jkg9m6tIfW/G6
HAhkZM6GxUl+uwcYib5oUCkYQyP+soMgpg1d5YLmpKNlDnZRNAJWRYvy/nhl4mHoC5doOlV6yp+a
NgCFYQJsl7sFXnG/7Xs1Q6IaKzcUmznwfR4Wdw4vpMycr4zpU0YJvjT3fJbI1hMrIM8oX/wG5H8K
fehY4USLNS3ypq8Zd+/SLMBpfl1x/SvI0dKGDQqPR8kInZ+AO+Fp8inMf1rvNiidHHiChLP1XmOO
Sg7pBKGfKBAjk/FRjDhjN6xR4u3t1gHQBCJzkd4UUZV+Y2/H8x304/BvNhgP2AvSz4pFnwqY58/q
QUMJN60nx/T+SgTAjMZj1eN5Y0IdYOTH0NH5xxmet/4QRABGAsisVVigEWFcYqlMXp2wVktGCXgY
jGLzq0ul+5FElhH9wdJERicQqSiaCGowhxGyuXKGMl1OyM3ErXoz2lPNNgRKw6Qp2diVkcOOymD4
qsZ4TPdp6QnAykNcfksOpq8EdDCyveqzkga7ZGq3dIqU6sh48k+WyXjNt205JKq/rGMQpGfmwJKM
bYarlo9/jEYd3houovYvO3ksTa2a/O66B2q8djKg21o6Cpnp7Hfi4RfbMZMtIuJlKDJHX3blbdDi
Ot5eizkw/WIhiGbJAJDiFONUb9eKkYMWpUfOP8jnLyTpEOeBJ7vl1gI1z8DF++yS58Pt2xnXEJxW
MzxHhCyGmGRPwoKPisqd8HLBiOas13F8bdyav8cOCisfqoV5yCYRTvqV5ZCsqMqIGGw6LNfN41w0
E2tYmrz5Tpi4ZiedqPTVGdPZYjeMSdMEba//DTYkI9ZCjOSLccDxshWapn4Pmy8dj9k09C+4Fsdo
oyl7QVV0ScuCnGJcklfFRsOXGV43XoIgm+zJWwJY1gWbdOwxI0wt91Hfue1OJSq4R/LRiqOAsWu6
+Y+j81qOFNmi6BcRAQkk8FreSiVvXgipuwcPiUkS+Pq76r5NTExPS1WQeczea+PXKtqzcbps+E3Y
str/LOTqgluiL2HsYPbeG3eSt8QwcP1QmWHrnLu2MsemCCtM4ODSmnLNLCsrfzTrzqHf1CkeY2qK
OcGCu3Lw+1kXehteLkTSwd9RD2D/+FWs8pLVixsBY+l9tslx3vrnPkSBSZJSFuerwfMVeVKQnHrx
SNY9ZaAC+r8A4UwlQji3KHIUIMbMa7ZuKUAulCHVtFV2GXeQukXhmkeOlrT657Pn7g4ec1vSPjRD
/RXkoKR+wdPezM9OLufnGQUrk6ppDHnBGwmxkGc1M5Dgl1y8LAzfU67xaEzf4DlH00fa52NzsZ1B
iGtK9DfHXZ57ABSwC8RnjZSPTKMKO9w2kLiTcBwX/98/5d0jg4QcypHKi26jiO6mVPVZsKwYtcf9
Y6i7eT60ZdOdud65avDbmfEvEzEyjXzkR2gO5hh9ma5F95bMeR1cTeFH/sbW/MQfpc4b7xMnqRM8
BfBc+bRRJDN1hY6Fdog4LP3IId5QWmPxRBtK3oW9M1one6rxLFiXRrBn5/HTzapCyNv/IAlnDgrb
CMljPBtmd4B6AEcm5TS2b5ilgF8kYRfrBzYCjb9tNCP2L73wjpR8Z7B7d0gayuwJxhgLEk/q8h3N
ZCtXQzubx7Q3UI3qZVxQiMJwDQ5u6avpzE63Fe9Nr5ZxY/mdJJ6EtTc+bhPbTv4fu4LJPXZYLoZb
T+qdem9cyWPCKIWph48gm4f+r2Gti5woqFBjLE4fQBDVSO2JxTSodWhKsB2tANB7OGfYHqkzDSlt
V4XQx3sikaIL31wAXXheUWLEX6GQqf0Mz3AE+UWTewJE0wUPGgFKfynZ1u4ZfdQ1Iny0C0ecJYB7
Foeh5C8ATp9lDrpnYR2z0ZL5KwUjOnlg/GVnj+sqx8fyGgZd7b3iAXNBCDKGw8GHDtJa90ArMAxi
Q7bhm8MNeM2QQsg95b59QBlRhq/s/gjicpBVZhslZ3EzVZbOBx/gwcWYxHmNowIDooVZYFvoOjv5
tc3ojZVFAlIlqyiWooFHnwSPsbxM7d1QIjWrs6fKYpV+GrDf4OfFLYLVYJwh8qAqHKzjgiQyxcVo
wyN8dPukG3/cpTfzA1sklJokemfud+GwtP3incr9LTpPFB90Kj5XuC6RcH6TFI/uMmCiQIBbGXRj
RUj9zMCCIjfAFLEKPO7mk2DG1V7rhuV9o1Q8XNvIihAE2oD3AgxpEfbUju09BgRQ0mnEOnhAK3V1
3ah9ReNU/9DDBvFPxK/5o4OegWYhRMEiJVvq/7C5dSHjslKwQpqmKU2PU5OkT4iwl2QzgDzo1xq0
K8QStgdXhr0dezm+paxctyK/H0c+Zq51a1Vi4+deWz3Hs+qdnbdU9KnDhHQVZIpZZkK/7ODRDys/
3BVRzaDAD1MWEfU4gfCIqzbaeOyUeOqyzDSbkfvYeveZ6MrPYbDeEgw3eCkaa+8FXBVezSe8IgxC
hNeSxm5kcuM2XOsd/iJByRopKyf4ZVowGQ9Fxnaya1mohXMwXQZBLDVlGvhygjeiSqsF90LYXJvS
7t7mtlN3hNvi2LecYbF17cCiezdo+YW317zt3T6ceePeG0F5tRocGHOA5qKx2OeDH32laRj8C1EQ
UxAs0fi3qGRFwEOvFRgCIO4v3SArEjcJ3KlR49TTO30tko45G52LV6OUItbLpBQjLU6tQ8wAE+c1
ESXp0VE+QCEEErhIl4zEhX2GA+MnQLcwv9y5BvNjhOYUvGnLTndbzVmSrSXCwnxf2m1GvmfV/imj
0m7osy2FbpJgU/eQUKw1Wx+N/6WN2OpvGKzbhpmiEgasKm5vZM5F+TjOrc8CCTqK/Q4FBxIdhGpa
wDGoxHKZlhxAr+NGSh8q2at2N9vM3NHmtKJck/LqWIcC7zYNupvD5YI8MMg1eYw2A8EAk9MmZgv2
5FNHQhGFd9z3aFd1xnM4W/X84f0/YSZvpwynrSDr7YrCfjpSCXnpVYhGfdKZVv1eONIHhNBroOyJ
SPsNLi2FKQdq2s6VtdlZAcEgK7Jz52lX9VGXHasMyTv0Eydi4MlLw5BPmmDax6yXqgeHCmE5+74c
/e0QB+Ke7ZGNeXMQfurdYj166svPiI0mMGTu9Z5lbvAekxwGga1k3YkrOwTEBkyeiIJMWIOhXRLi
rakDKipPtpJyO0oTqZ682SmPniwzC7St2y87h+GYuslx6f9FyF7ZYMxz6FTnvknmjRZ3/jXTpWUz
Wszqzwxr2W5YDf6G2wiSn7Ab/Ba3UoQq2zkUHPf0kib3Pls085jPp8z6cVwbexuLHq/aIsbTbrYe
AU6UB7YPy/Mikjaa9gI3kkeBjUVf8HUYl8W8u1jWGUUT8pCqiik1E2mxhoWjh+uzK/Idx4l1Q8Co
nHUz4LSOiPQrZLUNpReM6zplo4C4unPpTHWtv+c+LM7+hE5rHTF6j/ZSu7KFmATPR1JKBlS467mS
HTc4boDgSDPtTEj7JReBqUEUsxFZwA4srDNlGiF9reVUWB8pEsRzp8tgWksYOfOO+EDST1sL2QAV
JZUwMKNl+FjwBFU7lHhgkQcNlgj5cPPEAWe/EAsSL09dG1DgsdpsamqlCctZqe7cZd+vLEAI5fBJ
Wh2aDgcZEYLYOn6LEcJ9s0sUOd/hxAADbZRwD00VVo9O6zU/TX0nhiwtnOQ2imb3kls9l/+wiAmW
Ut7Y50o5s/6t7CxSTzb+xR0Fs6Knn31Zvzqq8pNTwJ67PNkMyvZe5nYoKqZa2E+K7SGSD0eKH8+5
PylZKAxhf43fwD5xQ1yeM8BDs5XEkcRUJtph9u04idosKoHsTTokgUGsENz0ZZ7G2NtUqCGCzcS3
UGzv/FSPI578zh0d1Fxz0w9d/tzN9mjvPU3q5goCBkMW1mogNEZh49NhZK6teM8uWbI37JM48Pfx
qPR9F9K7y7OXdtNf0i3kv5aS6AIJMkWfIEir3vddMC5vaMmpNnxniv92WiXDtXOs+MaBAxUL3fIA
SswF17pyB6r84/9zQT5tM3NBIoHvYvFnCBKynu0WP8kWOjknZ6XS2vqxeoy9QnRF+Fikmf+O16Ox
v9it1uGzqTknUVJyFdqkJy/KXzu+vQxf7jTaFkuju/Jhk6ZtGCMGwbm8MnQACOSrVHXHDBhv8IpE
xwOHxU7U+uoXD8s3/KgOaGDu4JaKCg15XPsuzHSbfwFC1cerA7mqPhknSMwGo395QenXJ1e+ovIL
R2dB0EavgpGIh6a/6h6MJ1xbNY7nwUlJklulbpXwQvOV1z8JcyH56am+FzQOdUEsFyNXpOr0RHwt
mu+XCg+MlsfZU5G7HYITuOD9AxUz4GP5BnUQhZwBdjweuy6c6kMZINfdecA5u1NKhecfbNePryWd
5HLz1ILmow+WKSEkJBXJkS4YMfbKZk8Zn9p79vYNScGy7O3MV/ajdgGPVwDSUAIQrFNgZm41VWrN
b4v9sYiE/1S7RXe6e2SXbXNfEADLcG8SeNU/MTNL24yIpBALkyO+wQDonHAFS3ZwTZgk/Wsxmn78
M1hVXw/ovrpgfm7CtLS2nZnuD7oQktaBSuo1EQVx0CvDg/TDQs4SX3eBg7uFgBi7N8dkOjpGimbt
Sli4PC3EWfgXxJVMBUNe8eGDIaYu91HpWtM67aMBDszc9RvQKeWw7RlacJuGdxfsupSenH7mOO5h
EvP4TsOyjoLFvFnAu91HH5QX22dCpRn3b9Rs4YG/92xXRO1d+8AsUfa7hqYCEUZa0rijZyymn2Gu
NYPFTpk/uVHxfPPHqcW7PYwRYTmctzjbfOOPT0xSHAf53V1exZWTPsC9DComcAzU2OUTpLUW/mzq
J1I6+3KfjuwT14bckJNdDZKMCzNwihZZrpoNyL7g8e7IpV0ilNFbycmprFtNDtm88t2eeJWhhbm4
sw1ucKhfBMBvjG8lL+R+COeEwDfg19DJWO06KAKvUwtUfw01PSAzZRpTtm/TGCTBrsoc60R6EpIV
kcPj2bIJpZpSQ+i065w8T0w4OcomQjny3KlmyMGJ3W0WADpy5zJ1+7WjfI5ZR0T9A+OguzYTAu0m
wYy98GlMMPrwfVCBmFSDBGNgUdU7BjBs2CGL32lngvDIdTDAF3dbNXWkz7jKbBjqNrckx469buOe
TgGBe0cWwj0WeHaAzK3DwRpttnqD/ydQlW7eBozf4pGNry3WrUwclJ9ACq/IDotzB2FxWS85vjKS
0arcnAjXy/85QIGSXQLu7OwGXZaAPXDb6a3OWwt18xBZ55wkJXnJbHeJTlnmNyWQLG/6Fwmlsw+O
svGpirKgObGqxSq7CliQPeWRM93pxLZhkhiOSEhdkixJL58UzYVhY8ogyqHMcfSAgZbw6mEbN2nz
iQdxKR/5Nuv6hIWOcLY5A4F2ZIeIp4DH3J3/5pQ83Bla9tUaW58gnUAwwt5w0bCet1RsyOauiSGi
oI5Ln8SRAlm7wn4frhyNtSoElmujsc2aUwlAGoQP07BD0BI7AT+QYdZGI4UqtgsL0+cFYWBwYEso
p7dyCPCg9IAbDp3XFckaJfs9eJLwm+Z5SJDvyMhU1ks44azkeGPZd2N84D1ZDXOBW8InREZ6GjPi
8fCv7gMrR6Oq2Hj9NBU5wytlOo20IPCmvTVX2ZW1vfD2OSfIydiTSVGGAOB8iDxfk5bCAZy7WF/9
sH7EN2vvJUk2YCqbuut3c4qe/4V1ZfJKemqtDnURWntTDSSQ2G3YnYqQeePTxLoz/8Elr2HbhXLJ
/na5RQoqLFAefBakbvsxotg4BVZrE5Q5YVofWyupLmbBlLuausKFbRzgq1+HmJ7VadYQsdmCRX65
C7Q1AdqZiWzg3xjAOg6/58Yi14GpxMg2jSwVP3kcwd5NJ0g+QNhTCJ//ATzUSJnY6z3z/af8fmGQ
BdvChUSAnGAo9UdZxg126oCdoSCYmAkk+5Z6y3XYefuBWwdjDmFOzqqbS+CjOC30parZVd3sDhMU
swvsw8SgZs3WtDmsQRYgC+Uv6F6SLE0fL9vYGHC5PiOZ4OJBML2lI7l1a5WmxcdQhbm7C8maz4hU
X/zHuXaGeItNqfUxK97B2wurnCc0NCw4mOm6qCFyJ/rGgwTvBo7I0D40DMWDFbIa9Q2HLmXyFN/p
hjmlHIuxEQONJcuckL6cFm/lz1ASniJjIyUUdq6eGqoy+0CjID78Xjush/PQHDK03cttshFnIUFD
io2ZerHPuYK+TciGCqPnNKjCbruIvGMsPIj/mIga2juevL+U1OaEThQBss1ZDBll7Oz/7tpnUieJ
UnRPrVT6KQRn5K8ty6D+QZyGbXQm7OtOxG7JJdJF+dfpMwTsayq7cAexxYtfddinJwesZfkP+5IL
cw73q0DIRw40EELDZJ6Ubneyx70GPzG9ezSz9t/YcdvsECJ3YiiIfxlMvlO/jrGPfGbxsgT7b9KS
/7lhXTYOZ3gYITR53ETbBQI/ToXam196OCBUWlE6R1/k/wUAdgQwQMAmdfpAsMLMKz27aI9SKxAZ
qMopI30xQ0p6jsMs/68PJBIzCfgMqhzhRQ4ehXu+Jt51iqJg7JKXqVvGi5lZFq8bYlvjtT1UMzGJ
+MweBXdN/+rXYdys+naos309Wh5EiGhKHlip8YuLThOoVzuNOEcDHMBVFy9YBgwCVs4ptC6/VNg6
4S/2mLuvOk3u4SEogX0cdG+1+8bDpL8nmuBeGVos2o9t1RaHqUPgv57LYMHTlzjdGZjs9Iu4pyoJ
jaDSepgz7cWbtG9CeMUa+fsGAKKPG1XCOkBjT2zDwe7COSGCwIvJ43OqIv6PcRFHBqgQHW3omK0f
ZNF0j2ljg2+MPU9X78UcL6yZfJzrL/T14FKtgJZxjUIC6ZjIA3EgNk/PO7k0Up1MmfrNhVJv4j8U
lv8fdL0BYFUvgn0chSF4L1khv01w07dHMgQxzc2wxmJG6Xxg7+GQua+g1kM2xBJbFViaRIDbyNEJ
LpgwugPTDTV8JqEKAnl2KZPnr3qZOus4Eb957WWFE4lJo/cuEbHIddZ7xGuBMFgACBqr6VEAylSh
CST/Eg6AHXVyz/uTensTFVD7cjQ7r31HJNkB7HkKj67LtbjHGXhQYO2egR6LOpp2MRa0hk6kCwuv
w6TvriE73HpdOz9CEhIe4tiov/dduKm3InfjcQfigGwYBPiwuJvRDrsVgbJwSLlw9YUIyzvPCnEu
vck8WTCa3HzZsEbQ3SYyc/cxGnKcqGHQo22ZYGE+CAOh3+DnDmRN0gZ86a5hmazQEnOsQ1qz0fET
VbWKaWcicpX74RmiFXkU9KQWrjVbqFPXG9ldbJrhO1xxCMzesev2gdc0Xc5zMXrfuVXQtZPM0S+X
Ip/tn54wIrWOFxW89aao6cqx8pNGykmarrFPVzMLftqBLchG+UZznJCdkLtWS6qIHT1MhT2E1740
XNBQM5y31LTRA5PqIuPOS0vm5LUxl1o0BEKBTRl33QIZ7VqYLHucHBMm67bpyNezcl2nJy6e4rGi
bSX+0Qmi8DoxZsWp7Q7ufznwjb0TzAVy/ainU0QsKU9QMCcOCxGnNy4z26xYZEtna5YMCWbawJoT
KGF4nNrW+sTNL/6EZUukJkbldk8EUPlPCav5rQcC0xAhxQzi6WTzvIY0mzg3n8xKAEOesFBiwtej
GRYzU4p17wzI0GOnZ60buwNprQ3T28tIgJtY81IDgRrUgppvFfDwzptkmX29Vh7Qno1jrGLXMMhz
15XKXO+JLXqhtxPxTfcV/NjF22UB741Y1arUlaKBpL/VSIrhCw9MTdoh00u6KDce3mXRUIrZOVFS
OL4jRKPOyEuxrUM06RvgBxjFe0y+/zwxhm8FZS2JzGDMfuFKohYRk5n1VZlGtB8uG79t0JXaZ2Ro
sTiB2z58EOMBn0kiZXy0VYponXxmFDuQtT4q8p+iNc4LwBEZp73PpmocTn4VTvamEC4LkoLs5tvs
Mew+9PkwDUfTZ+EzRAPmBh5Ti4gfXZMynPGZk7EETWdFKAVdfh3F5CZiCE3DQ9j6AVIegenySD44
WmQYZIJ4P2Ij3116COsXiXEMlst03XXyTZI8uWOApJq53SdCHwQ/vo+rcsvkKWXJnpRe3X/4TRwt
R7o1PUIWbSJw6mG82IeOT5r5NwmA9h2a5JfPpG/Mj7MOaFNS/GZHLG5JtVOkZDYPrLrCM/Rdn4dO
4tmBuNDAml7IqinPFWQ2Zx93/2eyT2EImLQBgD+Qi7WNltjr9pkH1eMbkb54NBNF4cYhBkOvRQe4
i+prhrWxRgCSElAyGRWU3UoBHCj22ARHfJC+5QguL88pyR5wl6dRuAHT38L0TxX4NibGg4+F6923
yQL4qSBUyHMEWxaWWBQk2lG3MPWQVG/42+rZ4rouHEYXzDxdlqFciAYEUlgSd7yAGeDBzkZm+w7i
mheICqbZmcmETxSWXrMdlqk+q760x43veFjXm4WC5JO2KE32bA1GRuGF6E+RCzRvQ7HhRttykP1b
PWvaA5XaBujQnPmHJmDmvBWdkH/xCGsOR831sVJ1LT7yUYRn0JP5Z9gQbLEilkWTkdfJ9qfpbDrq
tiFigfhbFDMrnwUZHY4z+De0nDEJeUHTh9uh6+sGz2NTHF1ENvowN83k7RnPkBZECcnidioQWu9J
aWi+FnI7rU/bnslXt4DilfQz8XggsXS6RXh8EVhYbdH8WBYq3XUE9YAaVjZICQnesxh9pF3lfkOx
XYrjQIjAtYevMq1EPA//AbXI5WbxXNyyi8TQfSB7wsgt07OmOo1muTsX4C+hWiX5LWK9h48drZvf
/wmcxP9NVYvTO7SGcsFdR+RzOtZYJTCplukxrR3rCXN7hyctRHJxIZMhts/U5zFK6Fm0xt83BGcl
R4J5yw18SeQaa8BHcXWIIngkZ+POUGjAESBk8xhor+loqvTM5nZ+ijMe0gNuzpm7WaakfHY+VyiS
PjA6Oyp75HFLYFr/BVccUZ1VolN3i/sIFwFCVWMgY3ikLwFWo3PJeubnUNBdnWbbYCgliRlgiubp
3kJgL4FS0i2f0aiNf7Tsss/+FEWBQ9GqOkHgCgh+tHwr6seFyp4/B2Zvx4a16JxNjp/D3RINReae
bDwa2op2boEDgTuQtCj+xxt8VSj24UMMW6r96J9GRjqgPm5ZBDUe7cLKp+1njtOVyUfi1ow0HyVr
mPiFjDhsljAaI3ybvCQIYc5z2Sv3H1XIku9GLqh/Dfk3X2ogOPsYhS0wK8OCZkHYINia8ATW0Ql3
RXciiSCJT6rtnZchkhWvJdsKZ1dipzIn8iKm/0hitv/UTIHK+wtThlu8N5Il6BCqZdPZULnRElr9
A7Q2Y72JESdUPGdMGZg3Fi6NcpIh2WI6VujXCr6MfY0TZtl/VUFEwH5GkshnCsXK++QBxHux7gE9
xYeUL1/8dnKwneOcoeZjvqUmqzwEgWsXeFeF9x9NdIt+f+IrOsWTJD12YznegD7SYwr31/JzCvCQ
d4+AhLjv7CMALPzEFlLe+ODMPJSnGLMrjg6BeJQTSUCgj33bUwHprait1zJmlKs3YgIWCzkFzAmb
ONfyuca0yyVkx6klrwoks3XmzkuXbRIBXN9C3ZDy2XFa9s64XcZsZ4/8xA+ooxFnmd7vjtKypHtc
Ar9kJudJnFojoC6XXsby213SBuUDz2lMqtnIlB7ocQF/Jhgquc2AY3l8pCyTp5OdIsJjRuyHwVuF
xQFOXNkFLgviRn/amRI/LdqZ6LXHnAgMnwXhKTK9JmFX5sEz57xFqtlsGLWCJqgvo/II32yXCqk+
AJvo0LOkIsveGdyzBhs87SkxabaVFYZMF7G1VBs/nDx/h8QgKD/cnNXHMTWU5K9RCsFkpYcklVfi
JRBBQ5SWGeqCvJLpCyNZn+a9YFAg90MLuZvRbnXnUkQ+eFZw6QG7m82SWPSsq6AlyfQFgZVXPSxg
qrIdk7T4t25glGJZRI62qwZyMdeVY1hI0SKR3TcFavq0lnH6TAMjrYPyVeBdmalh5UNKWWw6GCV/
a6085Iwyd7030zuOtaqwdhu0hZJB04JWoVjNo41lPtd6MtuKsJuILCtP1QevWaJwC6KTkBbQXApj
+Ege0inRRfhKZK16YKDGwiS6q/E3UNT7kkAglNbcO8r9CnKi21cU0TOg0NhHwLhgPyCezLMJ3gnt
2P+mpOCc6Wvqs72YGWOsYmQOCG5Lgo32VeQROI/rE/6pGHxzQ5Edlm8Bw7x7mLAWZ36t2eW8RESy
KeII7KbrAu6NSjWXXxHu9RnsgMpG61n2NeKXTENewfqLiuMdiq+EL4idBx2+QTQgt53O++wck+6M
NNfy0uI8K+PVX4skwe+HH6qLf5Qv2sD5qXs2qgcs6km0a9zefRhCuhp84GlirccC0sWJW2gBSUlh
yN/pyNp6zgFYMbRZVLsML6axmwJNuAZDcNJAy+RO+wzGTuwr9PyTimL8vONN4c+YZWQaGcf2BnZD
6jHIcaokPWKtDiywwCpAGzoko322OluG64kcQnWR5UjGYsRgjrFy5iW1IQaNExW2BTi6dO0UXfhw
38WgZcqzCtykhvK1Qu4bnHMRJ6SJg7lBDE+OOJ0yEimor/eephmXIN9PYZV7W3JweKVkD/kFnGIj
xxemzyHAoTnixIdpYpn1lKBkQwEbedxtzZDEf/C1jNGT6riPL8W0SD4fyZ+NHnOp5/6VVLwuf5Ko
du6aHe3E1BIk5mBpZsV5rIFhwecD14fhPp8zCeYKp/IumCJBEwG5WCH2y+J438gUbP/Kmfic7uLB
ZdD+hnNw4ZEJxsH7ov2dnmzp1g502gx3AmMzebJZL1m09paHXD4oxAs53AupXaaE5rHFz1jxsHPY
YrPJVLPXsm2DNy/K6DVZUS47vNl4H1pAQANicPY37KQMu/0sEMEbhy4acezEkresCzTBiOC3vvsx
EH9TGHOojThAgZNGDJEQX9j2R8o4lnBKdISElNvK/56ygvxqChQy4uk9iZyMFZE8AE+4RG9og8j0
cp3afWxn6ZOtBtKZKrLpA063VRuD9cGL3gGBEEWU2dsZsdM9/kT69n6B2vrK+pntSo3SuthLBh2I
w5L/hyND8sMrojthn7xJRDlMeklOc1dR37A2HMgqHbrJ+0abAsKEPRrGwzlkWg9+tfXLc1R1/s5l
dEHAS1vKaUNBKThvSaVDby7ziVWc1si/OJUUtHY8E4ykubTjNaiN5F822C3Ri83YfhH06/7VGXl8
SRlnv3RGsC5QJv4FKUvKg4Nx/OhWDNBWRJHn1i+nMwL/uOch3FI6EgJaWk6A0KwESXhpGg9Inefq
tj5kE1pZpHHQyx9SmvDviglWvgm6IH+1lfc46SkqH7t8Epcg0MW0njvfJS1mDmA7RrNlu4dWTh78
D5aETMphQWQcESg4X+jeB7lj47pkUNY1xU9Zzjn1adVTdYH+W0yNJ7OiqwRdhCwQrn1dPAVKjNlV
i6X44yyN52yrCsOD5jezaIbWdPXLbzGjLNxXi6umNZpVQrgTTad4chgI9us6cHK1sgrZIISoK/uj
Gwvz0Tpt0O6q0DjRtssdyz03SRR/8kyM7R64qZ98jKVLex5YPWPzIJjltZrpNDYhKkACoyeVEPjU
xmLm3o3FaxQaYupUNCzje9cauJwm8u1LQ9ZJtYFeQkYo4zB32jSOl77Xs40fyy1gZ2BAYusYbaYI
Fd7anvq+uuI4aahz6xotz+zM9tmefWKrFXZUiBlhom00cHlFRfhqYwe0n0eMWdmZqDRVfzNMH4BF
dykGqpkncYrLZ/rh5BMmHyM3DFpMunQQJ97aT2wLg2JSoQGuNj3hA0jvGglcbt2ljTVcljrQaj3T
DWUvo992HGJT4EebCOEZ7sKR4R+sM5wqE+Ljro1Lj0Nd2xjmekvzM96VJ1hVGLvCh+IBH50+2ddN
jyVWlZWKAKkDbFIsN9okZ6KWK1w9rTKMLOtMauS/xgodRON482g1yt51GnufEm1ilitW5JQ1bWvh
we9uQmWts6MfU837XNsLGV6uq4ZoV2Rxj7lcphiXe4nx+blSnuaDBTcHiQLpscaCyYo7mk/dgrhx
NxGcU13bsJbykmcD5+PZSbyGjBX020SPbBrOOQ8YgvL1nmW91r9spyb/M2Zvmr93aYXCmTAUAApr
pyfedpN3aqkvNiN8NGYVc13YYWE8wJBqAyzzI4P1cu/U/PGXtMQFBXeNBQbyXaV965Rrptf7xa7S
7NaWKDhXjAFa/qPKmBSyXUKIAEr4sbsMzlROX3nSCKLYrNkjvMEu63WkvP5MKo23vNjA59yTGkuI
UZYzj8FR0x5Pq4zClCBRUiqYPNRypgj2WthMe8NS4Q9dkcExUAQO0jNKS/RVXNI1aKAElhD9FUjR
U8eiVa9j7YqFrhnO9sYB+wkeQdqm3gwNyuJNJCxdPts56X/dqpXE6F67mYsLEdgAxenKUkLq51y4
fX1FcDD3776hJ2biWSTJxrcmvIQu8lyAJrIZ/sSQi5OHPo2HS+3o7hXxt10d3FaADJNYRGzGCA3B
NrNLfVjWgglR49Q2+6GsHS75pIEjlyaeUKC04x0T1kCP+qpzNLOYg4rwt+D9Mltoo7IkooVCdDWk
0MUQqNoRWHS+GC/Yu22E1juDzysPc7T0LOGoFcs1Oi5iUeE341GKsojgRe5Bija2MkZdp0bQvNct
hGlCdycUhQUhLNGxGDwdfjoMcz8a9MAoYZDmXNMyz5YHaxzt6hvuSJfdiEHgJGDvbxZE4l0ZBS+a
7q3dAGAwP01vUcg3PpXJAZV8/IliWB1BmKHFRy1n89LTZF3GqkXbONwLNQIemUO9soZogzOUXdwG
NpJMZ23ayZkOGrWB2LaVM8hbysOLTawE+/FgaYIeNhPX3m/YIbLfC+nrFF8kI8dV54Qy3zi1KqMT
T3R788H+3UMbjPpiX1J2G1/SIYAX6efTxPdtr43PuPnSojZAywGQdjh3SiWLPvh6caq/ix/O1om/
IaheMqedbmTATvbFErb/QWXoVSU5zlMOgxNkA4qTtcr70PmYKm+aiz3fRZGwnsZU6DNvJOz0W6Wu
jgmzCfL3jAUrgWsFLx9mvjtV/YU1ZpSyFI/q4S3Ok6TDdy86rJXw8Upn51OhlVeW0nH8zcu7uBBy
WfOjaGjTxN7Qd97N/ENlCE7G9dQFFWwAkec/QwHF835W0hflvhB3AErhB2IjwpJxny7jHmWlzjKv
fTH8Y3ksfE5hzlDm0d5rswzTKY1yuAwtdwuZN3mDb1lJQPKQg/37o1bk8ofmzOs/KuymJ54wg7Z+
DPFrkcBBe0i2ugf6N4FM/Is7y/cOQZiTVp+Cu1cfJfsURfYU3zoO/9lBftbCHdwJtOMfPsHxDwgc
CA0EgNWbHZljYkB6EauJAUlQDQyuQu8dbqQkvK0cLfcN5b7X7A1yJOdY3LFAlFNkGj1LH5ePNsNY
HkqI6Ok29x2FGxTJ3NmkKomIVsJ7sXUd/ICULlZ8tNWE86hf8uKXl7z7NnjfQcxK2/1kq0RC3Qwq
MdqnUhDfzG5NfdZB7BBmO/bJ+9JW+gZ7inl2gwcC0RsR0/g+Gm+sf6nKIvOvsNz/cXQeS5LiUBT9
IiIECBDbJG15b3pDVFVXC+9BwNfPYbYzMROVmSA9c++53C+NR0DmXo9dOl9hOSmfqnBU/xKYJIZ0
dscoJLIKXFaWDFUeIRif17dgls6lJynNjSyXzi8amNM2LHa4ik6sWWMEwtUIOiWtPPlcq27J8WCB
qersYquYGrt0WWds4eoo0bOZISKBoxc1TIhtymYqy2M6zH63N1RmhEKCaSdbGPkxyb9zwzI5CXWN
cKZLmWjCrETiSG1md8SWjM5xJLDcOuSe5906uTWiBFnd7J7rhf38FDoOgPku8Fjn17PfBlFqcTod
iVaZ1Smegw0YPk86G97jfEMQFZ3SHWoegT2z16b/yu0UFpuCKoQNmIiECVdCzzTVccuXCrkO7zmF
nNwZ7CugZDFNO/2TGUNEAjsU+KtzO2Ew/rem8MOjzkgrj8qFCQ+YBAJySlBv+tkG4Y4qT4TLG/s+
KmjAgBaUSGDtQEtTu0bYGxjrt8/a9FqWdZhf1atukrPl6+q2yonQxgrYTpOzm9PVJcVbMuvZT9jM
Pmd8c/oq9cH0vVE5ZNej6KpsM9aG9a0hTkL8LJ5DHhXu3RgOj+V0Hzw2wLo11oU2YqrswTzyM/3m
2lhuTm3poL+8QPsu588JxwCi1tkLi9PIPO0JbKD6OyHuQ50/lbb8NPEwzrdk/xDqiWoWijOA/ppQ
sAFr/k4lTsP+0a5+8F6oW0JzkTW4eD+eA+OQRIySQop7ZTEKay/2Kla2nlBZxrvK9gYX9FlX2g/e
OqfuyeM2ChGIWzLvmuM45YVpkaYTpTBCFENWSAVfeUos10RDsxDfFXYgpx2Y6NyiWWGxzxKxFeov
Xikl+SNIgj6j0pkCgo8R7O7KtGf8gMvRwMgR/YKJOrV76PbV4oOWknRL+PBKPDBUnvNN2JDRfZRG
qCtwE/H3FMDZ3I+F7TYf1JFTRro9Z8WXAznjDbbJSFaIrn6DbjKnSs7uG0aN4DfhRib/wqYjwDlO
XheR53chigPDgAZAHnYVKAr019NynkUGw68hFeQNpTaHPjY7buM2FuxHgtZhSpMY34uvYQevf9Cq
rF+YNd0/sI75MI5i2cNcD6PdMUBYtOXrYMVLSXhZz+tIyRDhMsHQFFIKfhAWba9882E4n4nnGDf/
IM35PdPkzH9AU1UJxC9UXO2tlzr+egPC0Fr2eAgDXObkqgAEtDcYV1fRJfFuB9ACO9RW5Xfb+Ka/
NFCbIB4EblZcx0CuLCjNZKU8eYL/KtvFaDUZEaPA5/hskNveQnXNMRtOXfC0NgPRG4j3U7KsR9xu
vA1kI6dcoa9uI6y/2ONt9xwALROPczLE3N5oDEhSwa1W7zu3LLO7TfP+yltCyEyfFUsEGydzWNAu
+dmx2xyOdR6T2fWDwwVJ6BA78jySlcLaNJPzjR9mvbxkxHMCaqPmB3GPEYnIlTRkmV+/WUVW0oil
dM2k2mKTP7hTSQKPHCdnAMaWmObP3DldsHdbe1hPrHPz5Uox12IjD4a5+ou6OOSLyHi/68/Shy54
wm3gmuOWGLS8ebk1DVGWb0BQkBdEjLDsauPwyc14z6lcpY+TDNM/5CXC1aIub8it3WUoWHaittrw
XmvKqSs/LPsWOi9K9Pi4XecQYgritRw5bJpX13ZeKpZoCbvRpa8il8h1J1qJ6pyeCyr55AhcSzzV
Gh7nTmy/MuPOckhPmH7ykBFHzYla6MGgLzKluBFClWcCKAmwoEVa2zM0H+QDGaX9Z7YEWBxCTtrz
hPaVz4so7QFKjR9/AyRLcdRov6XkiTvyAVk6LbdsNYiziBPPAog5eeC7FEfuq3EWpHijtNmizr7b
gW8crOUgHLd1H5JlWrlt8PcjEUJV/TIkzoI/cU3b20lwPYdOY8JjIm0mU6xpqxX9byFJvkUJ0j3R
T3RYe3EX/aqyddtrggcMAQZzOt7w3pcBal3RvCDXIAIclQf9S2flJoZSuIzJYaw97z5je7gC1cRG
mnbt+l3zvmu6qxHYMcN6z8bLyfoPPAqg2xiWAn5Y8guCM04cNuPQZQDxtbR/CLHc0MlOLqdOdenp
wqZDB365Go+sVFLnwO9qY4FPjGLjVIzuemiZ74T9vqvZv/gntB4D56NI4VTaT06e0eW1nWdZp6F2
l+7kOT3fgpOyYeBR1KhGMmsRr6P0TEGzZaFPaAQzp71I0zj4ndeiiYmGIsoD+VkLTa8Cjo3yysw9
rxiT1eIJOeOy3GUNpiueZdi29Tg1XKbEJ9yyIh0ZiI6cbiewCd4Xqw+G0jN99XBqKzj0F4SU6K7S
HM5C5OHfeNnsYQn3s9Vinqim/jazKHBfRkbN586anYHZsB6oGofCQQJI8oHGP4TKYbgyFhfGHmsM
RychbJW+8knChWDfK33PrB0wkMG9Yw6Bkuv8OmUDQSqUDQnMOk1K5YfKRXEbaugGZDPjp8HGjUB8
cGXEsJTjPLZa9S2RmYDJa1H27nvm5YwYqmR8XHVP7AmTB3VFHAeZjE0e62s7t1T41opxPBcEg+Q7
X00IJogHW9CYhWRH0Q+abpWiOgHydMwNO9kkeIKIBNaXKb26K21BelWNY+13Tem698gqjYzEZl44
+2UyAzryQrpwC0GrQW3lynOTLKBdR48IAgqgSqkj9cto7huikg4FDXpw0OA53JtehV176Eg3kbtp
BFJwzDOHimtK7SC7zLDSfls9o7vDpAh9k7DAf92qMdEmfgDrG44LMStnVlLpemknA6UwzSjYeZMl
Eeuwszp9GtjnsOgNWq7ouwaVSeDya/TNdM7zvv/TZ/PgoXMi+XnL+wbywL3djX3a3OCobdV09ono
669y4RQ26h6u0w+7bfAklAYSEUKttuSnMc7MvrPFyRghf4fq2NHGfLVBk0/oEJZ2mZBrAn35jEVR
n2CMleJNIhHPn6B6xN3dDB2LiFbY/WAHATH6W3BqGmO+c1hIM1tc4S+gYsNJvGsZtGXPfhmgSQhI
2Fas8xMq4ozaHfdSrnv/DicF4UBsADZyy0ri0BLVTs+WIc+nfnOzlDlBd2nOQLFdHcgafVxZlzbl
ZWUWVDA7J95uIP8G7S7HP/vyYmFhGx9koSraKJ5KGWdHJyH6EmrLCIP4KS+FHW5YFqufn0KE+4gv
Wq8ph11OsOWijzQYhWz361KHfzyryJN9a1tr/9oQ55bvC3TKdxjR5ufUijOzwwXLoGemi1dRD874
tmIg+VR2FMpsLHtz5SoX7aaHnf9JWzqlmzHEtR+J0swuAVLq5dSAr5WfFt16RnALmqAsmqxMw/xb
0wJYZT/16+cqDfLciJe7gK4rHINoQ7p++GeFSzX+rPnszpfFJr3nWSlw1aAgDJwigDV5EbNJRW26
DLsybpC6iCCF1CYT5sR3Y4Dy5FrBl2NZWMZIJ/dceJ48EtltKXIuSCuv7zgFY4neU3usJvHYg9xC
PA4f5SSZtCnvDLMKTuieJq4enZ3DLhKmOxK3tPhRLgI1jkwOZyT6pHCBVssJdUStSDGQWDdWOzvL
7Vhpr/nLRHBmhBPbwsfXXjupfaogIyHgK/C6452HCb2q4YAyP9dfta1C5yDnZNbXDhSWkcxLe07i
9WPmzvqbIJSbqaV6UTwS+4JVYd8gHpmpePvCvsvScLNV0QG/dSUWvidWkq78aNzBgu/hyMlOb2qx
dt5hniG9HFAS5+OvpJGQMfvWBGxGN3EDe3esdL0SmWMdQ7il3HGTe0Vauo3YKc06fHjFMnV3GD2n
/MBhWFT3sKMkMkPgd/om9VB1PHQ2XfZ3PPcgoQ52L+eYvTKKzwQbPZsa/8ejpnA2VXBcfLhcb9g/
RkZZV6GAxvyx4NpDHV/2jUhZvtUsjIxhv9fsHfzc4YFKHywO/0dAxF/hPK6+fpE4H9gssmdJg1PN
1nn67qWyO0y7SWMdTd359km1A4XzCjAwAVIUkL6x7xGLhcRiqdgI/NQldVbkWKSrsAJPgvoGgXio
iV1LV8nWBcHLpC+93XkCpFfrm+W7JlE4OE3SZ08KqxfT8meeUTyjyXQSvZ9k3SzoLk1Y3sx569TE
qCe00VMMHuTbNh6IG8M8akATwU0Q34MD4YrAzmezzwoTYZ0ZANvzPoE+HqBL9HiLOSGmyT01mZ+q
xwQGPw05zlH/6KP9dB8X4TX6HK8DBUrsOdrZ58Ir8ZdNIrGtF7syuTo6JFQunLuozG8HFiswToJA
NP1paRJJudBn5SpPdpl6lC8dLEorIE98pk/DbrE6KaRB5EKo9kNqHXC5EBuOYAfbKj+XYCBkjUWD
g5F4tSmw+ZPJFsrEbmF73nzmwzD4L36LlJZAps4nt8gExGJGdWYSt8dsTnfLLpmpWNjsgwzzCf+Q
zcV3NS55FeHH681u1rGQn7lKuiy55vUJXIzTOcp9XAQVp+sPj1xJt70SRXOrRReDNfNZr+9U1vpQ
MjtJngObsRkCFEAjzAc0zw2fpeMO/5gZg7g3rC5y8etXSO/R6s4WeGPU1FIRNpEzGIVqTMS5L9DV
g3UM5Nlt9OiiQVzYLlyVPkPXs5Eq3eyQwuWAJ0qETCzcNYj0Bsb/kYfW409BSTf9RQDBBJCII0eN
pKW0YFQkCJee288Y62kgJIMGSxoefWm3vg+v2kW7zNB6EP6DckHsjDB3IT5hFa2T8Ql48dSGVwy2
e0hyEbbQFD5PhR+4SO8CkEImuwNeWBt1rKGwte0BY7BTgmCsRCBUBFYfI/VCNoJB3q6ydTrmVRYU
n8zAw+lardk6nEzVkV1R6jA1RzrXgOAkuJjJsRE2CX1WL+EZMcHACWvsZSF9aaOQXpj8DxM64QSh
Z9eXDvwwo9SANRgc2KEc/flS0GYhF+VLKvclgjZgfQgXmJ1lRfqElLZl5O9NOclHLR1EtGCUaPZV
Rfm/t0w4UCUxyqBxSyrS65BWO7veXQjbZXbjLeeAJaDYs90SaCuyJDwLQpe/OeuZN5aZL29qdyDk
Ft3Fe1sIZzyIMq8MvvEee5fETcJ4yYsRFGBHYETazMl0IUIq/u1rl7jlxotV/4t+xPO+6HLshp8E
iVzko3MhmBdIpHlEXkcszji74BfqrC+DIyM+GMl521tRTfQamz93sib2epxL/b7B9GdwohCv/J0r
U18jHskg7uUrDZVNAU9tVHgzLhDt4HZTIEtxlLd5et33XR1eQ2WYauzOBUI3TbK9c2BLRdUWaE2k
SZClPFiBVWfIO+vZWzkaQTui9VXJhzXU6XouYTr2PNt2FV9zCKCjGiY1/CQsIF9EIWa2v1jSkNLb
NaVxJVGCMKaiZGA+Tu+2U7mqvd2Mnw7qxOLzDlggUYlfCrn7bSgC3sPiUpMcKHR8tCj0KskV6TPB
dI+WPEsvfegN4jqYi8U7kByRvPaTVAp5MO3gLXzz9i1TqC+//EozoKs8eFt7pDCuPja5bf3Ryit+
ByznFb+G3b+O1rrguSITsIwMUrBvaDIwAMjpZZvQxFs+5+SL9gnPculcVpLdfgrtNzWsJwjkCP6a
NSVRUBuHjV9mrnvonL/DhEgMWmkYro/kaiX3NUio5RSXpddGLHu3cJtaBPUhIO2ZEJouqM7IkBO5
t5s6bBmHooJ8HBzWTsehI7bqfh0Y8j+zuCKlg+8nqTltiU/asTvwTnRL4PSSPn+DseD+8+o0O6O5
BoOPsyt9ke2o26vMd2FjkMMDN91Xlrhb9IQ1mOjR8mkScqqPpb/YigSmUBK1Bwq33Uk/7Z/bas6Z
U3MYHTPUz9VJpbW+V5It93lyGXwRy1OE+FYnoiQPVt/60KVkEoudGzCLvk+q0vigyEeJ+6EfFLMZ
nVmRb6d4FATz1uDCuGW+BJaNsmk0gaRjqDTuHzKi2zu4vcTxWH6AJdVGR0SILd4ZYipC3zpVXUxq
Ro5oIGcQLRE84TpkJU3wqPVQqxlqIeCbzN2hWtPINrFCbac1rrdj6/Maf8Uap9s+iC3vCQkSUPux
MvqxLUX2V1qZuKmYmDOT+5/iZYUeuv58XbcDEXM+qsVyGWC0DxlTNXC91Y0HxwIB2dAL1pk4wUMy
kuCd5RvVcLgGRhCgR+tXbhs/L82PbVMOByQdgOEI6vQyEVWwjZywB6IVnCTZXdZaDnvhN+1yjfhd
Nzeo1/BMzFnySe23+IR8NfplxAziXRkvIREL60P+XllD850RLv83A8NpX21Jzy9WhyYzYuFYXbV8
pHSf4DVncmOTx/FS2334pjlHn7w5bwqkYBy+ApF+J15KkLvNhbSe6cgKkG9ZxQFBhW7jmShAnd5T
4gCWnYFDx99MsFyUHWDMipPwMtc5i1alP6sQ61/FnolExnHNTiGEW2x7ViHUmYJvYWMZ8ulJsBYa
LyuvTki/K0ywL9GBEP2lvf5mgDQoWZTzpDBCqT3QnjJnfEZC03plxikA0IUS/xbV1aAv/IIuUGcb
cfS+El7OzqMJae5mK4+BeA9Fb18PmBzT3ejOGK+4eau7pUvNhH/B2GCLHLvauyv4nZt17dq3UeXj
B0ZIeDuhpfL8EGiqyWgc7K1ZTHXzp2UuBBQlZd72WVlT/7dbBc78cDCEJaEbyXx1XTiVP31jzWNS
C5zY/9Zm4aUcHdmyeEGqeWJCAM3Wh9Z3ZMsYgxcjp4aHeI3Rbu78KtY/NsqeHKjd2rtnlZIKvquh
83CyIp13js7YqOp2bJVXHXu6PTdyg9brnmUZsx/3e2LX3S4ZyQMh9nV7gbvhxWiQLQe2qxt3EG0F
YUpU8qStAYuhCa4ItzitHWqYyAwSd4VOEufTZ0vs3fQkh80vFVZrCDhuUhLxi5YJZ7Q1wQByY8u+
qDEsiH7JOwplf4i96hq1GXmi0Cnqn8xaGVKnlPrPqpb5B7Yz/R0DzTOHauEeR+QR0rAOU4ANPpXd
fdxQMEY6mSCs10OnPyk38CrBePLZ2NVxy4xIs9vbBYzbYgQ467j3ApfcLEKtijLKJUiAWiJSo6mV
lnxCE8Qe0k8JbZ6J8lYPpe27f6ELTEDRZed+FQkyk/PsGRplt0YDRDDYEhx8oo+qexePSc5dnor8
zha4+u5M2nkbMhVYAo4rhRV9X3hqvUBon+EZljN8RVGGjbtPZxtzTGPyXu6dvh3haCI7HM7tVM9Q
0EBv2Cc7RDjIX1USdDTALdkneJDFDiuIGh9NRxO0Ux2+1qu697JzNdI3XC9t0gIT7xgM7FZaIu+Q
WGMWHDnHlwtNhkQ5TOyrb90ZiWcjOIuYNuiAG9Wd3pmWJuK+bFgv/MODg6n7MAYNZNLjhPI61beF
RjzhndJpLfrhkAUYUKk8vGHZQAnO+h7zVyFGmcN4JERh9NxXq56QtqZj1oVUaykWh4kE4R6CuO8O
duQbPN7keku3/GqTwr8eB2wG2FAQF5RkRaFF3ueLHNtbpHlLfxzNUiMxRCRjzXuPgizmQXcs3JJt
zDDvia0vzgkPpm67yxfKUVgOgdO9+zkKjhNu3aa+W3CQWtgrY7jQEaiuKnkgICx1mIWvjHHQ4SyI
jFml8qFS/iiCEpT2iyi35GquDedjel45p1F+kS6o8SojO7qgKBnoLGUwbXkEfsjZgTWuiFZPzK/J
GnYSV3BfdkeERnZ5sNEoPnkaM9o+KIkZYsBiFa8ZQQLObdz41LBMJxCgMuvv5CtzuvE35N2lZFbe
RHLg7HM74xHyBftB8m0jHpjtFgjqtjz5jTcF58Zm2MyeC9TNmXWPo/+SAoY8Eqyh9I91kyAIDzAC
J2eCdhaXVbrsRHXtJeMw/uWed9Jb4BF8XxnGvg22U8tnZyvbn9BG6PgZGtW2Y1xWCcSgWHiijxnO
8uRoVpBgXHVaOWfpaWSYFLPje7AkS3rSGi3zru1nzGe050jbaewFU5bEpofxqRwh2PiFKqNMUfpG
FZol+8mjw2fbUJK4nt0nCiMrFwGoqXyFAE1tBB0SyINSngJg1CwPFD8OR6eCHnULBNL77QF5LDfM
NFT/MtmCbDim5C2SosAKLmUOTOnRpFTAHw3OCv/saiZFiKoqg0U9Wafdoj1rfE8ST9VXtUFiGzFr
bQTzo7YL79167sWB0aXgiiDFsv7n2CwJjwjaPFioSZUwFHXhfT6jg5+Ky5QYhmgMZ0LEUBqxp3x0
kaR+jvjG3NuOcOPhaMfUGbAWHN6ZJefnOk4EvG9UiW42bYQJMCFou+uQofywkm/raLvRb5EHzjZM
eRIPEKpacZO8NKVavigvlumxDcl5JsnI2N4JTZyDtchqpCp3aNKr5lbTPWfXhDoE2V1Tsw7ah4AO
WWLjCamY9CA5dzF2YheE0++4UFgZiSt4TSi0mjYkUQBXW39To4UZukdADSvlB4IARI2eEYBUFsRW
JTdMGFsPqW8HXfdCw2FIKNW2LtlJWetAXkUr48F/bzCyzMAuRrzt/Bvlhu+DCpf+bxbSTZ8xTI3e
mbGdnb5z29nWAzN0Ez9JnbX9mWqGAEIzBy7ectfmNim9XlYPM2rt5LBtgeyz8PDGHQjg7V5orVlw
s30SRJXEElt6XHrUqFQ7PWm0EDGsDhmSPDKtNhTaDplH6qrRGHMOvpf25Q/gAvgXcxKkH600+tJZ
jcWoxLcdh8yPeHotNrEdVDtHzBd7yvCOSW38nzjr1z7qGFUTUpRb3J9BODl3Pk7EmMx2ntX9dnn5
2xzWfw8dEESMwOFJsRKswdcgHALSWfV2d14nMW5UqxbjlQgRgLLEWfIG+IACWdpVar2KAyxPDMBm
2JLtpEQLSNAQ29Mj/9BRPiBZ6Qo1/7GqtHhckjBJMFglHhpOxNkQnmHnvc8NVyPWyU6/igQ2DPN6
Y91amCFwNPW8UBESPYp6ZGxy2pJ60zcU2MO/1DTokyxE+eyYm9TjP4GkwYjdSkGbUwf+xaCNVdlD
XxyzVcYTuPfiEcskgnDEytQi6j3386zetwjwP1D6s+5L/dkQR4sf8ROVjUOuEJErF98j5e4wMSp/
G9Zt69M75XLX8ZDewj5kylnktRrfwY8WX+vq9Bt6zcRWlASj+whSyDwZJx4+ibas/jm9zL/jJYiv
HMeMwB4bpPq7mXscOxxioy8mpWixuqXtmgOpVKF1CMsi+wjHClSejSL6M8XP9myhlk8QPCNI2Rus
jXdlQq7WLuxqFFnA3rqfPqdQYfPu5I9Ybt23ULjOvzxN/w91GscgWlXZodce/VZAyLRzEgTRI7PP
05W951HjXJwRo+Z79srltUKrCSGJNOR2h6YR9rIBa1px6LX4HBfZEnKEjZLVRhZzrhGewiqpVD5m
IkdmnLdrtmCsaBPkbDvVCxoDmj6rwPkn63+dbHo/InSz+6XEqtODY6ogpXapoHtmlRNcD8gQBY4r
yW5c1Q2ftSUDJ6W7CMLiyneLAQMS59VIphRSViVQraBgzOLpxGFQ/pqpld+W4bzdwOGldTU2fvsT
sPQLUfWVFQGxIdP5g7YgZB3GVbZ3g2urZ+4c7Z8J7CPmYUFJCzSj4nvajZyrNHFWGnSXbtisWWbS
xXPX9mRXOtzXBP/WrHEPNkuYf7IfrReDRvi8to1zD3t5o/CAb+rZouUJEhSu9siEmVOe0lhjVluS
Ql13xRq+VtAyxmiE94Desa4xkqQORQq6EGzAITvCBwsZTXsxpXKepmlIHtvY5i5EUriAVFj0fMcS
pALggbjc3SVAzK4x/63fYqIwjxKXSOydP9OMs3O1cd7KaZ7fjFjgadKTsglli92h13YrGbFnLS8e
8qcpGjtveGTR1r5keqlvs4oUrR0qGuZnXh/0jwV0SKY1Opj/2XmGmoTdmH9y86Goj4MgxvxokcPL
4egwb2IYMq9/sFm1z6qbNLISsXmIh8muyiN1E8HnvPf1FAmLcupQeelqIpMqMFjI68SOUV/+kOUi
+cYeFTAqMrWX7vE6Zk8h/W0Q8cqVX6NrBT9hNkzZnieBKK2GzuwphArEn2Hj7DmwUWivw824EK26
tBi4rU3+2oULypXSMt6NbuzKOYZUTu0u6DMOUN0xTyJdiHN1FwIx++jmOcCk7PP7UzXEPBpcaEiG
OBtguI9Naj8Qmcg5BbjL/tIstHmoajZH/TIUH97oFB8AXqrPYXCRWtpikTdsH7KXuPJhRg9V45WX
qczKUzFDBdzPbLo/EebQHMVBi7jfrMiiqB0yyt7AqSF0OujPkzM0CNblPTbY6SIrumgVIwEHA7Ww
9Op4GcE4NQ3lAPk3yK5s5vjnaZqo/rmygx8i3zsTTdrrPkqazmfXt8hmxhKiMAi17AvwD80HC2/W
nyJJpnujMPNRXjseRdtUynWTZjEMAz1XvFoC7dcOi6lAJal1aPYMffrsIJAFIe3sGQfv+jHcMO2s
Xhjq1IH9pnh/WbH7VQ6i3NDz7nSnxyFiRjQ1bMrRBhyQUsCFJv44f/fIBxO7NTekn+ddr8DPTQkJ
Em0f031p8GLyWHJU3qlg1ddIZZp5Dyc/059Zn7j/UsRP/g5VV8+UvRiwZZRJ/UXbUVyL1GwhAcaG
YkzXoRUBLEv1Dh/YXu6Z2XZQQtBw3Sbc0OXFzmaIJ8A9SpBGTgsBNFuXpj5XXbZJMWFVwIdqO6EP
Fojm6RqkJZtF2aH5ZGZhe3dTW1q/I/Lsk7f96XBdtcFMR/Dpj7+UNnp4DHy4MiZvE8HmHezCMGva
53wug++w6w23KGcgflaYIYdFOBL6EhPRGzlKcJz0ZiB9FHC1gq07a469XULT2XWOU85EJACa28FL
MAK8tBOQS4xMlr5qRbgdjezaoDAZync6s6Ssd+AWhp4lKa3wwaYZIhDO6Z0UC6PQVxUHEcNjUmX+
WROXXmTBgWHt4QMLwhpTLRLhU0YQnZPDFN0JOkQrArHbvA7wB0GTsU2/YU/MVkuIie5O2KZ6L0jR
zeDw1/Eb4n0MoLE27LUG9pj8PDjPbQIMt3DNWW1O7IruzWnKz64oq+SaEkLe8wS0KMWbLPnGrFy/
ArFkDt3EUpdX2plnJvSWYDyQslLqj92k6ueYLB0K6Fx7txLnE6Ce2TefWg/c0yw7ZLdPbEcHh8kn
8H4nnLJB68Poem/YeClaV1yTiPf77t71nQkXv2e137zrJGf4flz/m3ECETyL7ALxqhyzLxXitXZH
esljJRKIUbj1hseQYCJmjlldXRC1NxODqIB8sq3sZNIRzM57AY6exQir4831TGANYEtVXQqdbHuA
PkdDOGInJtmAdSz3UZugwHXdmeeUH7S6m0Fz/2iIRsTirG3aRsmQ67ceienMq1sNd6ouZ4ttBq/r
zslHHC2F2w1kIYTxL484sxyYxBVT9kw8czaWz3qtumrvDf3yx8aO8cjmYfAi5uwtUHDIWXcsHTc5
A+F270GwmAuRtlJEax+KjVwVg9mw9ZRrECbz+mEjf74tZxyhezGC3ODrE8zfAm9q0O6TSm2iltoz
3vFl0O8vsw3lS7BnpWzJLa/eF6Hl3to8jaS6pKW6JiYc+xI/p1Pv3c5lhbjMLuXYQBKliCzTOay0
qU+wB9lraA5dbvndAeE23z4HUfBWyJThbYLgh6FH27jn3to+WlPa7bvvKBq4cp6ynoDbon5cys0+
RXmr9hUg/myb8mCVbSlq8RIVksZsxEhw7nDiEO2STtMr6YfVM6339E3cYI7VqCdQx2LY0EQVw8ty
l5A9LiK9lvYJqhexX72j3YZaqcrfkLF3bz2MvozrcXM3pBYjFyqtJIHckNFWuFMa/ONYUcEeP0qG
m7gYzFcCP+t9bdjD7nyXce6BXLnUP7cKs9lJU7Xe92qk+UIxnqEHM0X65kocDUA7SbC/SnqrekJr
mKDfwUqPdyuu5s+kodqKkqpBwQ3V0b5wdtHS9whTir2FesCcsRfoO6Y9rLdcZh/wG1MuHiLMSi+L
8B/6IW79VHMLsPkGp65r810WrH6OuKX6g03IAOvCFgEOs86us/Ys9afkiUGzpuBqams/444Ud8NM
z7sPqwLt2aLY114Gokhf8Pj2Z9CCgj3higSSvS27VlbZTjYesnGNgTTwSLh7mD3u52gNECY7oiqH
S6KwvR+3x8Xj6+UtOrDVhs5BCwrXEi1hR3qXFfjt0cIKTQtFbvgCdZB48rluKbAKJaFIKEkMAsIl
AmJZsfYCWGJYm5OyTTtGlJ9cHliX26eAVDN9bG1//tOn88aG6RxMxOxeJYIG1B8EfA1j/cWgVQI4
cLCm7CwkyK8Z6Bt4MjZhe7u2QpC5l3kOtUeIFK1IB3sboF1a219DA446wrfv3K+QiVDNeIaUqQkd
F4mtg+TwVuEGoO2T3KwXe87S/liVfvGuFhQHuwYeF3oMKobiPPRNSNw07r74RKoXjQijQ6CmHc3N
v2zM8EU6AwqvS2kFPVxDihkGj9LI+KwZlmCCnwnKhkxU3K7LJC18cHqqXvyAoJQ9Voo4vMs4n/+M
iUlYGtWtsvdtFRsaWIJ/vxkNQCUZ575hrMRSz32EItN0ezyY2UOad66JaPEb0r1JouK9wF5COLei
zNm7npV8rLJECa5TVz8UU+UOB3Kg5GkKBOlLs5ePt1R8c3pyaCrTneQiErz9I9ydnhHGDyio7Msm
23RLJLKq7gWiu3osxciK0az4VE7eiFoULXNHe8cyIYX0DauKKY/TZl9YUatfDOd2HRUixsdBRqW9
HizpJxYuLxwfHOupxVSFTgUmH+VdQjzmtOfC7KhlYIB9TLkC6Yduw/+S/qo6/DKujThTJ1uMtT9O
53j0JOJIwu6qo6Lm/XUZQep9hracEjPz7AcsRFy4Xs3+DmPW8KvmEukua/gA7BJOufg0CZz4ACy8
8g0BETu8ph/kgZFKgaQx17RyBUyGFyZuzU3LWA7fVdFV5qUEfRjs0OewdkGqQ/wy0maHwWQWZBvY
n4xSXXrpuUeQEvAUlwt4fAau498VoVV26Du0Fnu7CJaPnNP9b8Vx9LwAq02j/0g7r125lWRNv8pB
Xx9imCSTZjBnLsouJ2kZSVXSDSG36b3n089H9RnMKi6CBWk20PuitaEopo2M+E0qzXFv8+hEST/z
5Ge9CdN7tcLzZGdkOu10XWZfE0sHVYPaVP6IBJr/YdRtA/JBEw//UKftf6lQXL6QUOZ3NhXXcJcj
Boi+lVEn+xhd0s8+E/xMtwrgUNRQ1w/8DIn7wkkNcObJVGtz8qbq6eYkGFRB8Ines8NQPyLbbbsc
cXg8oJufpF9UUdmUeRg/AZ7xTXCrdtZqFCM4nnfCHxoOEVWTrfPiwE9LD7XfmtZGE0MX0QkqVcul
XOaqVdtAhkW05skAf1Duslxv9S84BjBMVkSzmRJ3Faj6rYeif0PfJhsKgEgUlmm4p6NGzWsrlIRW
cMD6nAw3aj041hgL9jS9B5WdUgjPiQxuPfCxt5Ogh449fIHQSB05ev+o4awKv0JyghWPrmZpdG7Q
GzBxagvNuPE+a6ZQE3vbMOewQotQYhGAmhaCly8h7tHI6Xe51dxjcucYB6MZQnk0sT5Mf8Bz1Sw0
JLS86lBrzDNzj9gDcop3uoOGKy8ATzTI0/uxMGH2Uvbs63e+3VhVemM7uDOZ93D46T7sA98OGJBe
z9Hm2VcRjAljj2hhj+CKj8PdRqXCr07vB9748Px6UjVHGR9jFP2TIzBweniIfXJIJkbNhc8NRXci
xGlQ2fYizfCnAPSEMyvkq0k1rEPSPcSmfERaBwvhre9DY0eGQeP4gRHkn0LMGZtNWIJVJbMIUgGv
1pQ6L3RyvZ2Bt+l7Cdw+o/8PZoQ+SsFLh57815KS2z+mYZSfwe6W1TZEfoCEKsHSZVsHrjzR3cbr
p8k0ASRP4o6+CzJINTvVs2N927Zm+c8EI8YtoDPCSSCllHDzgbdjig5eCMebIDV4kPXDP7YJ+RrH
7KSnHQTUn8wHmkO0h5ul3oAw1CRFiLx8lzeKHDbogjvfrbgbDmjCU5/HfKM26TzW1NEsQwck1zV1
8KUHtv/Vw1Iv2PepnlJ54rmGNxlNMXnD76AJbyuGOt5AoiLLR0qYpCzvC8TevVE2Bv9W7HdGAlGG
2qG0QAONNSzE3iRb3fK6ccs92kg4yWcS/5GgTZ0ztXVwLNBjE/POpJcPwrKKwEM6daI8q6ZBhUbq
YfGPr6X6sE1GKZt7Oyy1F3I+IFyeQ2K8GVU8RvedAfhlIyUSTIaq6uEtLilwTPKUlsoWQiQwpECz
MXvXDcUq7uppiexCqDTKUe36MUD1qABfg0YLqha2xDoMIc7R/mTypqWTCqBCw2Wv1SCHAQXFdaSI
sF3vBoBiPY0scjiNsk+eQwrneMApjWcwoG8UClIsRhq/tM2bqkzru9CtPHMXtFrXbm3pUo5AkoX/
GgUeuQnTzP0OpKg6OYBESVIhXvyydK38Buqxc7Y8bVjZuVYjK9+jcLsJamROd9DdjJOjUv89pGZc
PoEco8LEt0U3Dbj7J8SY+u8y1fN3monz7SGgi+PuMbUxnD2AO50bU59EkPQS1vDO0CAjbyVoZ1oR
rlnGW/w3qKuh+uqoG2kY6BjYrTvQKQ3Dn2mc0vdOq1R5j/xTjEqcpZZ3aZSixGyZdnFMAqwebx1o
+PdqXUZny+dAxk0UycEdGghgEUE8A2QStWlYGxcs8Qmwh4D7h2zXdz+IBgCBFk64UFSsaiMHLwg2
lIZ5+3gu3ZoNw8HNX1EV/WT6WvdFG+vs0ZVMFBXGlFJEqqBwj9mYjrDu0KnfwkSmv3jhBc+RmGqs
QaIPLXLsNuvNwJ0OSl5P3YbXHsQCkldIApbXhd/UDHlXEQUtPAYFcQe4UGNwcgZhmTsfUKFzyOlO
5xsSAhQ5kF+WEPcElzVS6J2PeARWXLCBodTh8WZ1P3j8DfgpF319zzzyKg+FG0yvLupxm4ajCNlL
VIXsSWfB+iIdY6IqjwkKNby9UnBxmdF84InVZzs4BrK5oTZZFtvGFPIRaZ/+G5zG8lvIi+WHk6C8
x4Nv7M8xfONnOqD1GYHv8qVHzTzfUHpBckfoJl+MXCQD8Z+w4cDNk+nvC5RM85tCtXzENkoHfcFD
k9MKugvA+mNkZcIt0Pb/+o//8b//14/+f3q/sscsHuix/0faJI9ZkNbVf/3L+Nd/0FeY/t/bn//1
L0uXqmpIwwFeaVHyBIvKn//49hykHv+x+E9fDfyqrGJjn+tJ/a5FND93/fZxPYh8GwQKia1htyI0
oGz6ZZCWoWO5mVhumQOVTrwxRmRdSKHo83egXv84mk1OL2yJ3pPOh11GYylAQLQtIHAq+eQeHhby
8IPmNHc6DYd/1oO9HT8h6S/YlukA0sPv8TJYhGQ+jXQswUChlXCXsPzkjFL083oY83IEJU8s1bF0
JKE1i0k2ZmEAqFDPAKV6DqtyeJgobPYTWZr7gGSsm97mJZCC8Mo4TuP0amn8Oyb8AYskyLJ0a/pN
r5aGSDAYNms1PmPeBRt7pKD4kx5t8KUd4b4NvugOaSfw3Vn/VPttWKES0rSosDnYwl+GbQGw5bII
orNZ9M+JS6W6tSPQPySQQAJ6nrinSEzwJmC6sbNdDz6bzumbCW7TJbXhAgpdXAYftIG+ZVpF51gr
yGszSDR3ILvj5mY9zsLYCtUwoZ9YGh9qOpdxzJLXK2H4SAVzHUXxuSa436jTdG39uUNa8pji9fBl
PepsH/776yRSQcK0DAOex2VUm/Z176ZWeGajTnqn8D4HPAvyEDhjVuf+u/Vwi4Mp2YKWacD8sKaf
82oBQaHAGUjJozMoJNqpIpQnX/eR11oPs7A3hOqoJgB22zQtOV8wYqx6RDPis5v1UEox8ikxcqcZ
Z3F7gcUqfM09rIdcmj6hsjylroLklbMjRplQuyWIpnPQGVrw3NkRyaFCpGHvdbmRfbULT22RDuWt
fbceemlQsXdig3BiW0AxLgfVq5DAB9XO1+YDhf+Q+nWBxq7X/sUKfR1ntkLtNhptEUj4JwD54JAX
3gvwuWKP8RoMBj9A2Dfzgu9/8XHUzjQTbWeNC+ny40RujxSf9fhsOVndfoiiQmufTD+sdn8TR3dM
kLA24zgbREh+VtLDLT73vOZQHK/U0XvOSnCVVxbK4myZgnaJraPFNv8gmv2glJo0OQNslscIVxVv
j5Iqvo/rH7S4IB1NpbOqCsvWZrMVx9KleuenZzO2vE/kI77Y66ruIPXHS40Ho9QrASIvJPldj7y0
+6Dq/N/Iuno5ZZxh8DzA151RLVc/CCtG1JGjR8BlQZH4e1VTNluPuPStmqqhD0QqobENLiOimRVi
Xlml57ABLOySwbyryz55UlFURjEyoztKBSq6EnXp7NRYkqAJTBPC8SxqUBhj3lVpesbLxQHJr475
d2QO87OFYcSP9S9cGtPXsWbLk15x1kOhYzYDvf7sKPWk21VgidzDUX5qobQ///8FnC0fB4i+qrdh
ek7suOTjFDNI91CW8hdRacaXIoU0+xfrhtML9WPqH7xTZ+PpY16p5XjsnbMuNo704mT9zg5x1NuO
sS0RaLNCs7hf/8yl3aiRG3LtakIa810C5ByGbdnEZ7rLVbEtXVxt9z3d8CvDubhC/1+c+Z6QaViI
0I5jBFH9b7R2B+gTvv4U2JG0P+I92wW3eAdb1xK2xSX6Kuzs9KyRE/Fbq4rPLXJYgmJM4gJ0Kugh
Hn23N4IrZ9tSOK4/23ZIe5nK2aLxa1Q7xiBIQAOq7iGCf3VLZuihbJ0EH9cnbmlAdcFul6ZtqjiP
XG55rsPcg0lL+qsZ/Y+J03CX6mAZNrHtHXn83qAA3lyZxKVNyPEiVck/GmCLy5hmQj9AQic8dzSX
rC36Svkt7CnrHpMwj3pkWpQP618pprNylnGL6c1iAYrRHM3WLkMOKCLWpmJwLdm1/80CyFC27a3S
ZqA8gGZN1SZosZSXepqQip3XB9lNjp7rP2NxXk1QYMhyOpYtpz9/lbaNTl3KRLfDs+KhvLFBoaO5
R8AHtjcvDkq469EWp9YmGZaCDiFzexlNhgpOiIMfnl2wzrdQjnOA+lCYn82EgmIeF/apd1Tjygm7
dBLoiJZO+ZvBG3F2whqosk3F3SkT9lVICkNb7SoKk/1u/euWxpJEhgyY9y8gy9nCjSGSA1xpo7OB
C9F907t5c+ijsRBAHQr3yvG2HEyyG21Nm9Lhy6Fssw6fDWcIzwimGt/Qn1bu1MwzUYNVm/36dy1t
DijnKq9rGgqOMQtV6wOgLUVn1oRqY15PH2nb+8XwiNEI0HyIh8WVGVtaJ1THDImQgq3q6mw7Fkmm
Jhbk33NTl6hE+1nffR8qk6pNo1O0wzmw7Msj5R1xLRNeGla2A+R9g6e3qs4yHLtyCy5EQbJPAwCD
0SAX+zGVOngRKgJX0m6xGE1qeH/jLs0KnX0nN6KbDkDJzuBly21Ozf2jJixkRKxCPyqQtHYcAg18
cnPoXgx0mhGa9E37sYJ8eE8bUiKqhLcbnTJKx58jpTBv16deTL9gfkqRZ04VCepFpNCXywzL1yzG
aTU+w84H+Y1AxE2ilOOvCPo7gDgRgQKW+lPrYJSJwKio8Ubh3acdfGw41n/L0jbm+exYbC6Tctts
auquUwXS6eE5zvCPRLNQRfsk69TK/4u77nWg+ayEWl9FecZTNlGrryOQbcj2rRDitsmAsl/ZXdPp
Mx9h/DdtCwwE9TJndjqplQT0aRdUIWgzZVuQtwpgptK06CIhKUetDz9RUN/Be7SOqu36mE7TNw+O
QtF05U3PW23aiK+O/7qvwDpDhTzhhK5AeqodGzZIrP2oQlXPHzGYMJQXdHyH8Gjnnm98hnFWaJ/W
f8TCLiDFZw9M+hVCE7MRaPLOLyt+20lqCGEhbhs35o1Ry/RznsFZuPLJC+PNFQBegNuO0sj8TR23
KEhQRnPg9jTlC9qaKLyJAiGTg4RGEOystEJIJ/W68kEpgQD+xR2oWeQZJBs0fam5Xw651kNOjArD
OQmg+/ZUBOd4pSdQOE+DwDDHNYBGP0ssBtMr99PScTNVLQ3TAhhE32y2mSfAWRHSTDmZrUnrrm00
wTEDg+kxT0AuHyhDe+nzqFQAGW2nU05k0PAwVFz79orroA2u123XP3gIA2Fzkg+N/m7oIUic1xfE
8g+1pxOYvc6JN1uWOt1H+Kuae3IQdsqOVOkwxlZlOzyiGKKiojLQZxMtRWhIp/3Y3Lrg97qjHwQ9
zfi8le7RK7iycNB2IuvIarCPIlbDKznc0sKlIuRwA2vsYDkbzxLSY+fmqn3qFBihBhyvhwD/ix9I
tDTjn6dOGukwM/L7HJ7X1yKENz0VG++T3qK0vJPGSBsyLzpxr7SpVyBgWnW+sc0b4QQf1qdj4ZCY
dqdkZ+oGj+HZZ+IU0WtkIc4JkDyKDU2N2UUXC179Rgqs5kNVyuwflATir1Uu4uceefPwZv0nLCQE
FIgkY43WryrM2ZEc09+EfO46JwBztH1RpYG3nGfGp8Yd4dpobWh/RR48krfrcRdSHzJjlLNoL7Bp
5gkrtt0NlEHhniDcdMBXuHfTSakOiW1vjIIjmsRBeuVblw4oBI2F4DqwYdTM0q3RiNCTyV33FKHe
HNzlLW27EFcXB7tBqLawJJuSlhX8bITe/PbL+hcvrWm8/GgEOFSqhZxFR4ItFRDPlFOYKNqwg7YX
g9LV7EIPb1qjLof9ejwx/YWzKwihIEbZ1E0ORHu217uW1YPTu0u5uBIV4ATbuh3dKBOfvbBXn9si
G17CephcAYICoF6vhTe2kqKymOBkzNCkmbpXbFe9UtBeSn3Ieigzq7zT3l7M2KTgeJXrykmi5/HZ
K8f2XcTY0K1FJTLctVWboARYm+gepjGkVTrpzmPsIxN1DOJpuNYHamEp0q5QaUxThaZCM7s3XItS
FeYmyil2aRvwMJSh8WuMA+B3VKbKHcl7r11Z/gtLkZe40JGvoQ0F5/TyrkosU8X+0XNOTWHpdxme
9fjq4rBt7xyziEC+dcjDHimAeC5Y0iB2P69/80LKN/X0prYUVUTDmBbrq/RExNjmgfGwTkoXJVih
Ojkc5qEFgrUeZ2ls6VxIxLBoteva7HgRgAEL+BbOKQ4SoFjpINQHy2+x/6hQYMVhIGvbp/WQCyea
zplCBYe41L9nn9aL1sl8jBNOwLOq+7DTO/9YB1oEwg63wy14LLrWmddx6qwHXvzW3/0TVAM4XaY5
fzWmsgEV43Sdc6rQsr5LcrcAaaUhjGyplvWpFR6yBn8RkfI7x5kuhGnPVlFLR3xAL8M9IbHs3Cn4
MX6Bmwsth8Itksc4rorDesSFQ4ybimf41Pvi0pjNZ9lk4IDd2jlFHKYHD23r+0gLPkZl33xaj7S0
QskkObnYkpr8ncm8Gk1a/kVNBkfdwofSybXvulsPZSvjL2YN7iuwYZVu5ZtTErVQau2JYp+MoqqP
am0U/ha+gvmsK8jBHtJMEV/Xv2xpDNkQ4Cx+N2bnV67ZiyaAkOCcEHus3B0uMyYmQCC3oMW1uFld
qWcsLUspHIaRGuNUjbpclkGO3IpoHPsEtC7fhmY2QvXFC24TQqXY+TgCOFeW5dLUTagBcB6kmmQV
lxFDpKHR3A6ck82K3Eu6NROoCeHLv5i613G0yzh6W/R63I7OCbmo7jl2wC8eMh1qCxpAkyiDrdXJ
zz+eu6ntYjuSwRQkbpchxWC3WJzo9knRtG+GGzmnUR9PZVSYT+uBlqqYRAIRYdlc36jxX0ZK0h6d
ECTBT46NmWVSl+o7nKY8Cw3hMj2ivoLhrHSg8GZKYJ9kB15fq/L41/rPWFg8BmUBUhZJJmrNqzY1
7zl8pXp2YY30vR6a4lOHn+SWeMl7gQPrlc9e2Bu8lqmYUrJR4QnOTrTMR+yocR3lhHo/Wfhoe0+R
6wv0ckCebNe/bWGZTsmnlJRNcQZUZ7GcqHCTVDPckzKmqLZjNTbg2RtMpdP1QAuDKDHEE1TcyDop
SFxOJVqBGJ2FQjkZdgWqF/V6sKJlIpXqBmO/tPokQmDdV94WCxkG+INpz+vABujxXQaFROR6ZT16
dIYww3rxU8/eC63HF0V2qOPvsEjR/He57wU4ZPfFtYWzlOQR3wL+QXcYiPFs/eL5aZZF73pniDSi
PWgsJAfOQTvZHoAhfBLS026pTQTAGFOMh6I+Tr9Ar0bCGsI5dhJ/Pgf8FDrIDtmiasw2rglMREst
xTtDZ4GLKNCqpbuaomsRgckP5Sg+rgfUlmadq5nskToQ9Ijpz19dYMDqcuSqLCbAVlAdpjgizwkv
oeJm6IRvIWqIqaX3CDRUx808z0Pj3MZtO2LRhpvTQUXiM7zx8G1B68AeRfAeNVUEbzvaYuXBMQ3U
oURieLgIjKQA3annGn0X2pUiPtjVROMCcKdGQEJjEGKemxvWPgfb4T2gOFaX39e/dmm1mVyhlA/Q
0OC6vvxYD32tqjMa5YQxumtFID0Lp/+QiCH92Lep9ZQIK7ntY9N6aDFl2q8HXzo0eOMgpIhwIAtu
ttSKChR74ITeGcn56rMboAiEfVxabSLKnVdiTX/X7FEFpMkiv7Moc/GCufzQoBHoA8jBPSFPwTsR
DQekJlxMRHPEnrt3Vu1BoJcQjyuEyDu12yA9b4RXFvNCikurl1OL00ujLj8r2Opa1ZRDPb3sUEHD
QxZbLe/FTX31mYM87nYNdPd3Qy375J8/H2nu9KkTwwBQU7z8es9KYP1YtXtykZHbmxXUXIxl4bip
vhyP67GWbkBpOYCSqOBLQ8yrI0UhgS3DxiGR90dEIPLEfVAVQJlI+YT9o8hwnTrYdq0hYiahWmGI
6CI/VLZln1+pRy29paVNmYTeE13aN+ioFKtWgSsYj3fTDh4arOAetdwxj/YgcEF0lfTFwgwC+w4T
zZhE6p/NGFPUqlRGth7iXZug97JredbSMmAyTEoHNDrJJi9no3GoGjSt7Z5yLUGM2wRIrd5kGMer
GywccrFREVpErcey/mL92YYjqcyTyBpzFIdnOYXIsXw+BbENLdCq+uaD6uMHB+00gsVTG2C78b7G
SHp9TSydqTZQOCnpdAIimd2kOhjktA8t59RipXarNnHwIQ3FLSru3YMylMrtX4RD0pQ8bBIGmr9B
1BGkbVL7LHenTD6ZPVXQTR4q2ra30Ea54+YL2vfrIZfOFw5QMme6uSC4Zlsb/YYud8KGOW0xj94E
ruluVDQnovc5PTmYeoWRQDKLmvhTaVTpwfBr+2X9Jywdp3ytKsEa2oKtd7msMoheVdmbzinAXuKm
JUmq0Uq1fjah32a79VhL98Z0XZAgUCSQ89pL01lIGgPEO8WIWBygB8L34RLsfyYqeBaB87bypMCQ
0CCIgkS/so6XjhiTyo80KRRY4MVnL4hBydBTb7g5upISj48p77PpmUa4N3A3NPZm1LF36sE9D7p9
8HzA9QeZAfK8ss4WRpyqJOAPSpMml9hsI1cCpEKJAvqpnihnvZZbxVF29bdWKYrgyogvxqLi4IAO
pBCqzmY3iUZEt7AoOI9JGdxGqOwgaYmt50FKoyv+PPOdWg3MD+03Sq6zHKhp1R4LnSA4t4UdPk1Y
tM3gJvG7FsYdJmLZtYb6wu753VEFdgFr5w30A55dCM+zCM6NHukQqMOgR/i6rMv4wfSG3xJ9g/ld
RXP6DnaB79/3aoN57vqaXhrhqSIzFS7Qo38Di8S5PMLvAwCBMvXYQcFlHzuQn2ejUvVrF9M0XbN8
xHwdbLZ06hbKUdNrwRmpPudHADhZPSahaI7lgEQ/qTa6EhtSCaRJJG/wlzprEajf9JDGYHDA96EE
rUvzm61ko7aF+juUV9bA4nAwGVxToDccU788TvTI0DGM5xei/NAj4FT6tnFM9Bp5cirh6DOtj/7C
FWFqgN5VTlB6kXOWBF58EsSdQ7gSyvUh1rC6OvRoXiNFCeLHfzDM5vt6yN+dxTeT4JiIf1t0UUj5
Lz/R9X3PA47inVPNAWK1gYVmPmPAM6BXgP51dtOqCATd1ggYPaSJY2LD41iR5W8a1GFvVXKXcYsZ
JKgkPLLyn3ZjdOIK4HlpFqjFTBcnlTuqhZc/MeX7sXkFtO4j6BAi9mXgHIG5wY1SIvtzZQ4Wg01N
YCCeEyRpNh5oSltJZSrBWeAF6n2oRqWuDyPWqvVxRCzuSlK6tAWmLoI+ZcJgzWZJQdHKwcLPIDwn
RerHO1kBXHxGhw5h+SvzrC1sNskiBlMiBQCaWSTg6RLBlgT50EJB2DOi3v0NMQh4aRomy8UW6BNq
EhroWSrOYX/r6mG+B9iaYf4oixsE69vD+k9aWu0S9DU3J9UintuX0xrXeePrnRqe7a9hULZ3MlWK
98L1AxeJFaO6dp4vXpgUSeV/x5OzGndFYqejfxGcDSMU7S3eXk1yaPQeNrlq+vcFVRb3ERsNDzJg
jRcRLyAY7olfZP5fnLImIFRq/UDemP/LL5/uEjIopM+0NCmGDZa54W5MW/2npIt6JU9YGmXqtYZJ
/VQlF5yt57HunBECagiHR0K0qnorwZOyAd+3UdvCMrakZuqVxbaQGVFA5RbRKRpNR8vl9/UYfmki
S4Jzwts2fee4fVQfBWKK7xBf9aJDUHTecGxy5DSxZulTxO3Xl9YUYH6osYGpPtIadjAKv/wBORLD
pATkRkpVT9WKpM0RXqLLQ121shADm5TTD5UBn+hvptbmm6l+UvrUp+PlVeVEUczGVdnTZz1T2s9d
PmADHTvcTkmbnNc/cumkovACaEOSgIp5G7okpwdIWPlnH32x8M5E1m8fGJF+SNKsUW/Wgy1NKV1G
ymI82qgiz0a06/OGwaIOmGjkkHtkNNDR8uDIP2f0qny0v8hRkJMOnVrZhBU/+kq2sLSOp4R6SpjJ
/OzZJRDoTWpl7uCd6cs7d8Diy+9NYVjBPh+QDtnRckke1z95aRFRlGHPkN8SevbJsq+MMNS5GRO3
RuhYc7XWuEOR08z2uSK9baHYLcoKKJR6VxbR4rfCt/vvyL/Lc68WkepGKtajNnmubTf6ng47+iTo
tqL80bmx520dMp50v/65i0EhRZJXg4QCv3K5cptOtbuY3O+sZdFUhkOz89uA0yVaO5Yo7yZf9OHK
2bQ0wr+RnFP2oVnWbE4F+ESqjLUPBlfUhxYRsU3AGX3jI53xmWdyX6PGEEbjlS9dDEsTkG0D906b
P9yQyJVN71FPzfANeHFxwXmpsOq7K1Tk1A5RgofSxosVjPfWR3ipEsOZwBU+nccAmWaHAxJIkqs1
UE6NKrrh3kaq/BZlCPRwPLW2sH2EQR/bQWndA6TFC9mydkrBGtiKshlRFVBz7VMNgNr7iwSLNg3N
bpa7xnPycup1pI8mBJh3rntMdOh0m91XlAvrn3ZUu1/WB2FpmVH70y3wOtNhMotlovuSjKbhnb0Y
jblt1lp9uytKOEJWK5pdjErT30y3wZqmJABz2zQuv46KFuwkNQ7Ok4HOcz/iY2sHef+PlkQt2r+U
DHaqgmreX3ynQbkVCOV0Ss/WNmIMAVLXvn8Ox2A806xp1MfOKfTx2QW4VO4MlGiv9dSn9TO/9khd
KfZQleDem40tKkXoDss2OKNLUn0pw2oSqRztfGvpCaJ36x+4uIskWbkwJmb3PFimJWlQQhCEKOtX
CIJgvvLEkwCXiKzXy/gQWxGaIWWQoX+1HnlpCU2AX8o81AGoa15OqD6GNa8x7lgfjaBvbeTbD4ha
tciva/7XYqBDcGUul8aVSi4334REZTovA7pKrKHAoPtngK6gqzWca9S7qJJ5vW95LgdXQEazkVWh
5E8EEIjIHFK8b2cpm9I7qW3iWXYg8zQO5MPTm6f0D/DejHvPTIx7F5HQw/qgzr7xd1AenbwM6A9P
ylmX32gi/BDgSScOPQ2hbROn8Z2GRMRGDkn3Z/P371B0IoDy867W5kU6200QP2x0gXZ3qKJRrCtb
vBVRg8qL4EHx0BRb/7Sl8SQlg8vKcw6KyWxb6O44AqBQxaHMIu2DVmNHHacCvnXUO1udvhISq1H4
N+PJo3VKhDntrdl1mmgD7tODg+WXjfkVyphox2B8u1e5866Emu2HaTxRWuHaJoFVSfOnp9+rdGEo
0ERrS+D1MlZwvcnjCL8Qjnnny2jVxs6TVnmlQbswokQkHC2Fae/PIiKoPyJGnmuHzvP6ncfpfQSy
ax0T6Zd4VPpfB4gRVzLQhQXKsiQW5BZYIMYsHfOtYjQR3BAHBdnIrUkp6NBZmEOYYVId1xfMLNn9
PaA0PXmcwU1kRGcbMFd7Q4scVz3oPf3KCN2lXUoPZKfj6bqllzMeKgw89y6aa1eW6tJHkgxJ3unQ
FJGhvZxKo7SHNMCIE7skN9mVg1pvsIAz9p5jj3+xamhtU3agYG/SJLgM5TR2bero9RzC3FMPk0bx
Nmza5AOneQEKq+7+Yv6mt8oEikaHb74hIpNyCtJW4kA/VztMzQlQ7W5y4xvDz/XpWxpE3n6TgsME
P5mDI0LKUZYapXyUP6Taz25IGvNJKL4qcCbyxvN6tLe7D7Te1F3jMJsq4bPLAesbTY8cDmq61OpB
AVu+D7TAQ/E4iO/UeKz36/Hefh2YR84yUFicLeQ1l/NW92Y+4reNxL6vyhsjNsXB18biq4mI7PN6
qDkQgo0wxQJYxlqcmoezfT4I3VMkRpsHMLVW+j7HoLL8YXbU3CsUAq2yOLZ9FXoHWddd+t4stShC
MqfRkvZjjuhuf6N1lkyv7M63hw/5zdQz5IWtQzqdLdy8HTFeViLzYHuuixIst2Lkfe9NY0x2cqBH
v7cDK8Buug0icbs+IguTDf9Uo4gkgdvCgbocfCprOcZVrTx4UVIjuJ/a2l3qa/YBPb9ia5m9fyX1
eHsU/T5lESKRVIUoDF8GBMnb8ZpInQPicdGhGUjuXHBct27tq6gNKtW7RHfdTee22ZUzfv5aYfJJ
BUh2aO1wDEp79q2+VetJSk0eR91cdTdYTNVbXtk9pe8m/za2en+fUNvADz01H/CJV5+KNsdIeOy7
j4ZV9PvEgcT5p+MP11iSE0091ImrczkcmKhlemBmpEZG5t9j3t3sI9T4732aj+9zaT/9eTi4HBRz
aAFR/5/24qubFeYDV11jaAeFh/hLocWRht9Ki/WGwNBtX8SGE19Z3W+3N2U6Wnpsb2Ycit1lSCbT
xjXK0w/4+QIDSapszDaVb2aHVjgYJa1/oJh28KsnA5M8yRlI8NS4iwFYmIUbp+6m4XGrVlXAo8TO
+41ZNdpzD5cAK6wWa4kR7jNw0uQ7J+jZcStri4A0NjgZJJz1X2Ms/BhONeqiDmkoKJXLb0ezDkN7
nkWH3KPcjsfDEG1Dr8bPbz3O2108icUA02OAmd15gq1WWtvG/qAdgnTwPyY4JN+DpE3uk6xVNjK2
v6+HW/gsHYkDC8Ae/9PEbCMhQ53CkuspLfSMsY/R8ns8RdXH9SgLC4ev4VqgSDfBPGZrNcdGKx9T
VTtkcWh85CUf45Qadd09BOTm2kvz7Rk8qbPwTPkNFmcwL2cK42qUv4WrHYzK97/5mP99sy3UHm+D
tlGqfS7rXjniMoWryh9/Je91jkPudVLBuQwWdfl6ytimZ9HYYMJklEjEV00BA0BRP63HWlgmxHLY
hqAfyXZny9EWGV7TRsvtN/jJnc9huQv1fLL3dfy9b0X+n6Gdp71InYCThmlk889v9so2e6Q7Ue43
o9G9idGPuLNIWG7hgeJ+NnTG/i++D6wzWeDE6plTLElrS7OsB9y/8XPdO9ogDlnkWttoeowNrllf
u1HeHDYTzI6ex8SgAc04pxrq0eDrdmEbh6IcrfKQY4b7omD5VmwKt6z2ql1ZYhNapUEzMa+wGLXi
yjkiJwhIKxXlVgdnfuXIebNr+ElTvQQCOzwPAN+XC3lMC72USi6Rc4zCe371sE/7pKB6MURXzto3
y4lQfPWk9jWBgOZ3lx+WYwAuyDiAecvfe3nTH/2x9/d1WOX7Fo2pK8vpzbFDPLpr3Fo0rok6zcar
y0sGrqtkiW4caq3E/KZK9DRHARL1x836OnoTCPkkTgOGD7o6dLzZYdDbSmUirpsdddF5L0ylvJOR
5l8pUr6Nwl+NftK07SE7zdO+AN+ZNKmx1ROZoid7RF81lMDdPu6x317/oDeLwuKw4n2Moh/INMuZ
vf9GPTbqPqvtI/2G6AdwDPMGSn6+EygW/qEKDkeoTdEVmQAiCTrws2w2prYuM72wj0FEW5vCf71z
TUV/cPX6PlYV9wpG6+0o8rqkhmXzCiOfnJNg2qhBAL3M7aNhDv1e18fx3i0M5WZ9AJ35WgdXxw3+
W1iLOhYmTJdrD6FmmqsZ3nWd0gnkEPFDSsvbqssacwfJQfPaTdtIq0Mm1WJIEXVO3SNoKl+/CxR8
rQAZRBrq91VlxSCv07jexhFaHhuvr4byIFJPfC1oYv7CZKp86QDbf4A9qT9KNzLw8S3i4VOO4u29
G5naC7p6tbrxGlzit1SkMezoQk/+CPs6b7ZIpqrvegRJv/mdBgyw0NLhvg6psu0sbcCWPSk1Z7yj
usSpFBl5jbWLNaATblql+oRsEpq7jhYrGUz8tm4f3NzCIzCLI2y69MpIthpA149uGXffEm3E+qu1
KFs8eJWBYQ5HQlHjQF977zNI9/WhSSwFG1nUD8cddd4kO1j4dGBLFakhfpqd5olHzCyrn12DmP6x
oTqzd0dXiE0r+7H7qYNQxoW+ZzfuO0MPOrSxSxklxhbWehTvYiPsk/wOH1+b1MrsZRXdCACour7B
vRED+J3mRE3yIUX6xt9jQSPdX7rRN7jXQL42tgFWScltnVNF39p+Uohqi0NoWTB4RsOLnvQwKDB2
7JzE2ah25rvKYXL6629xPu/7X0legC3tKPC0e5oaw3Bq4TBG2GqjyOYcK7y8r5Gkpg30OsOlBi/Z
Y/AXaKobb5T66rQcRe633j7wwuwYgv3cJSITWJJ7xkj/Hwk9LxuD2xTzlH1Z2+5ufS/MtwIJNgkZ
G4LDhKrHvOkjzExxPU2Ee/CCzS16CaieK0g0m0DrD1jZpy/r8d7sPTAyHFrcMiYPd5Bcs7QFK3k/
RoQ0vPN0iHyHztGw0xx7vBr2GK7qcFL9JPg/lJ3ZjpxIFoafCIl9uYXcKrP2xS77BtllGwi2YA3g
6efDc+PKajnlkWZ61Oo2kAQR5/znX9SVbeJ4e+V1jd9vO9yyT9OiD8Hem/CF2Hu2yJbdGDd6vG2a
VidEs7EJQEs6LKy+YngBAQhax6TfMGrO4ydUd6qOrIpa83aeEv04jsMwRTKzqxcS7suHkrJ4/Nwn
uJdvzUaZ/cb1clAEx8rJY287t8c7vFRGfFeOdU1kcmJC71JeQmWSYx7ZfunGAlfHLNdSEifzkbxG
EwP1uzwe7GuDtLw6XA/B7/qYjfa2bYSoboM2xctA9XpqHExh5r8MW+Skk+kNLQ/53ZYI7pVnysdO
jAmmph3xgca4LDeCQJDxxnO0ZasUAcdPqitz/cS9Ttl3qGiOjQ4Zj4Trfpk7ax9bjVfvE4U9jR9V
uWHmBzfv3KvJ6Dp1n03Yp+5nwj6LKMgn6yaojTn7YS1Btae/jAf81msKlK1jZuvwfDBnYATXyd0u
dA3RtjPujm1pviIqbCZ5UOQ0yYPfEHm194RIjOdJJoHXh5lyF+do0itqm7ENmuTemoU+PbnWYvzo
KbOME0CWkezlJIOEz9Msym3MTIoQitb1x9e/L8T/e3T8+ekxvYDEtrbpGAyBvq/n7B8VSJdmCgCI
yLxEkA/TRQ3Yirer+/WDT7W6Tsig5bNvd0QNuM/FFE+/YNG2w72sYg71vO4HAlNa8gNCJFzJcFi8
Kvuu+1V6m9Qc4dtytOMxQq0soT7wPZAQ1ppE9cKenCCwlRl+5ncscSUidCkmyWXzYvS8L72u70ct
UfJhwRKi3K1OafVW15VDjEJDMh8RMwq9wPWIAoiA8hk+Nf7puKhPhMraKr/RSpFl26op16S+bkK2
+9meO3v54mqL77yabVF/J0HXIkcKCWN35WcJaUcDDiozkVqzYRa3wUw67s9sjgPJRkTu9Hzbu0Vt
EJWbD9uSbAKxC5iFt2QLBBZu715hFXjPIBlE9S8JwxlTGWB0vqTwJdnP0HbAUV15t9kyYslvpCKJ
dwJY7tY266C7zaqqir+4bjkSE2nrc3OVDV4970TCx30DtUCqLb8NQE+cWeIYIwIggI48im5+UFiH
DIhGmLztnGzUw9wBGXlolaoOGE9OecS4d9CvZuK34pNGyf2gOUQ35qQvT6rjkDTbmeRIBv7iJcfY
9HVpy3jAGa/l66ujTmvSdlMW+OtsdAup04b0+tzZ4K5IUBbThlUB3ZmcciHh5jb+/b5F1p/c1KMc
Veimdabf6VUae2/eYmkLYb5WXW77tIXaEBpGQNAEJQsc5QZB1TNo8IKdOy59R0f4yVtL0umjJHjI
uOLn1+dN403itef7SQ7ow3nJAllJo21iZzH3li6EFyq3tpxITon1GndW5oRpPGQbjk6r2WfEas/f
qmwMjDsykrz5mww6i9eEkK24nfK0yMKiiafnZPA9EZl6rzZV1i1TiDC5QjxlQjvD9D5hHcdZ6iA1
82MBKVM5VfGC10X81dZkb91lSDR44YKE4p3byfLgKG02n8kem7PrTvkBOI4c6+w5trpSmHtVeJl3
FbSsfpR8WW+1zQY8Ji+3i62q+XkxJucnkauDVoT24jEsI0WRr57cNXJP91XCMXdIGiON3S0D586O
hJCL+IZxvGF/VjHmQJTlmOdNJ6Tswj6mS+qT8Wvk1nVL4o06zBLp7U2K5tU6LbFWGhvMjuS4JUgk
T8J08SdIiTVZgT8Yao3BiT/LoUyNrYHwQ48EeJyvEuyXkiydYMckWrZENfq5ILTyrpNfR6Oxim3X
ueYbYbqm9TZKScxMSkxC8qANVvvJNtBBEWE9WfN+VjCaokCm2YkjK59vWmg5E4AQp8u26A3tCoxB
o+wjLxDt49AQ2oLlP8K/nd7IZJqQ9JTpq84XTVKkKocX4sRM7RfVl1WFVhPX8ogeWxkQl3XjR6Kn
QrsAivwezr7baMHn14EqCAI9H/Ss9xutTReRT4xrj77RJf12sOqhuDJxfWk3VYtBayTqLvtWVLX/
YldOU5L84Unv3rdni+p1Ake/1qok09dy3CBRrWaeGT/SGIgUEVBCqAvVJto3TWN7+tzlvTjaBJU6
T5Wd2599pye0zsiCYrhySSP2L8zDjXO0iSEOUgcQX5jRDOHPmZtBj3AuxkTvqDA+lLui0vWbwaX7
k31b3YlZz4Ntbw8iC4NkitONpsN+mKva2szYlR81f/5iMyX4qZt1QQp2OY8v9jD+8GNluhc6n7XX
ff8mQPoQ/66qGyiX5lnjYzO/a5FTqaNy51mqcE0IIxBMSEab4ZRnRKP5mdBvPZ2Yxd1Kryj+cUTB
j4VP/DonRbxJF7vWo38cuvaQMlWLXf3Yg569MA4hnKseoXsOgs0SPTtV198P+vMKF/MGSAow7Rkl
AmDoZy2ssAfifRsoERpC2GJvLPFMHIzHuHYKhdMZZCgNraZdqHN/D9be/9RYN1J0QFwCTkKr8f5B
kxn5VDpJ55jTrVQPfruQZRqBk7VvFmngLvkx4xKH/OapttWGtpz2Mi05TO1Jc5Z7YsvYsfHtXn45
87xAt6qrkTSR2MHdY79ocfcdn42RhLnVZM4Liajxr8lRaMxNSXE75hdmDb/v98/nWQngK8l9bVVw
VzgfqpuEHTbKkv2potq0blDHIn8gIpQRNGV7Ft/L3Na6kPFIWUZxsbhvUqlBXQOQp7dk9VBT9rnZ
fKoC9tE19iPdDY4o9KM+kSSzh9qJvLNOy1mdJN4DX4XZimKbzZq2i+fcqi4gDb+lq38+D77a0LsQ
hKGOWiWQZygKH0Av8eRxj5BJhA7FQ9b1xh9plk6etIR/a1IW4tuVZP5RMwF15rCdTW+JiDTKYzPE
iS3wHvKxW0oSnIpifBYoGMUuqZyK/GY1ZGZERV7cuvw/edsWzMAurOwPGw/gGcM+TEpWSB084/0S
w+bVyx1r8o9J56srSYF3B84fXKMO934OrdIi/oHqEiT08aqAvGDO0G1X9d75bh5YZA2aWBecZOER
BdUKrFkOtfJG/z4p5iJ9JnWqh/NkZOalYfbv/endS2OqFnBRHoNWWT+nnlYY64ByyfJEPFAArcrv
SDTOLQ7OjLHrPaIuJUPRWHYXGp10zLs0bzpnZycz/tB5G+vjgZeX3c5CjG0VkvXtFPupNHG0Tcxi
2KAq0AR5W7L61fGM1k7mpF5dcCk5b/mB0oC2mIuiA0Qb9/s8+WMLTLouHUy90o6eS2Z2kCXflNPP
P9mcnHvO9mQ7G+lwV3eO83N2lvgCUPlbQvr+N8S7frUp9ZjOY1h8tvARDMEW4+FONgnk/tH1eoOw
VqqockNWFXEZk5XazZMHEttQxDjdvTkuzhTFMi+9LzD46mSLuQClejQuZVx+90knuyHl2a93+UL3
DMOu9ropTPVKaduCQ7slDXHAMwSKYepcz2ZmE05p27G2xZodIl1YpdL+YTvkYIVqmt0J/xvD7bdZ
Y6XJiWFYYJ4GMrf8cMblUvsie5p+cWVbighkcLdAJ6DW6LHsIOYJJPTvB8i5NGNFWaHXrdRjF2ku
f3n/nZFYH4Du6eKk3ARHdyuY+6PRLeoWcL7eg2iIU8DYPdSN5IecSMa2iqH/9vebOF80VE0MX+BV
gMdCojqfBAS1zJLYHcZT1TJkuiJmkyxJPm9DHBkXAtBaWIjoG9toFdGXTq1nJzsj73n3z7fBsB1v
KxjCkFXPF8+0LMrwi7Q/5d7cWlvlelM0SN0goMtMS4P806zfOkmu3YxTWZCmV9QX1u9vgOjP9csv
4cFVAUCCobsGa7x/Gy2JWAZ+k81JxUvi79Oe8KiwG/3Wv1r6gUzmLJ7G5ppusf1uN71vbkvXrm/z
floj+zRUJccGlrqK5NgTKTy02dhuWkw18j7sdXPuD/6oD2InxqK7rhe9mr7FvOMA3/DaP1V2TPAo
iSvy2AVJS+SV3zYSjeewaPtYy4dLxPdztJ/HZcC/Piinr8Uzv39chbgVN0OvPmm++zbpvjZuiOX+
nDa9tC8U6h/G7eu1gELgLvB+GSmeXUuI3i8yWtUTSXZvk5F3dhgXqFW2YzNnezkA8KLAs7x6R4JZ
+aKQ520IThq+AC6OV3DuuktanfPijT2eJAWGYDhIwvo/d3TCd3tS7Szak4YWNot6pA5hVeVNH+kO
aGxkdtlySfz/m/z8foUx8uBHwGdp3TzOSze2E1efmn44ZSsr4YTPB0nCY21240HlvTkSRtOgHTp1
OkErT7NbFvKuIRJvk8NKL16XFKztNQCzucvSQEu2VVC0J5pU0wPlbY3hh12Zatp57lLEe8EIog8X
N/GyTZXnwv0yOqTo0ptVmXJuW4BB9YDChvOWFr1/1ew608SuKUuzJi6QrRoMijypW90hg37798/9
95D17KeAx4UoD83QShM9WxFSxZpdJWN9wgqxvyVLlqz0nCDj4mAw/PTDPl4TDFuna/D0G3r5tuB2
6O8MIdQc+R2L9AhtWd9kcEmySAo3/VRIMi4P02LgkSVJXLzC+hR3yAs3vvaUZzeOPpi+E3slEqnO
Wad9BbcgVXV78jxW8F1Xc6jfkG4mtgZ2p8WpyYl315cW21XNLJz0ThvtvIsGC9ea3VTlmff5wh2t
Bf/ZHTHEXc2g+YxRsp71IYTLzj7JABNbpyVPk4voKx4m694w6ruh8dN7DO7ie5o+86pF00jIr5ws
uTJlp89JCyfzwk/0H58WlmUIXFbTcsiBZ692SsuYAr2wTh2QONDVQvKwZ1TL3m6gEiw6E+4LV/xw
kNJDrLRcF2rcSnY+Vx2QhFsYsab3J0uNSRsp6VVTZPVlpm94maWswtZWZvdoCP6hrY+/EiAY8Bd0
nrywnAtv5OMPwONzE2QyEeP14W6UZ8eJLt325HSem10VC5M8Yjjt0f2Ow3EmN11d2peML9Zf9Y9V
QJnAg8MOoYJerSjOxx8ycCYvhnu+zUoMKW5Go3PTz2pgrnyYbT+OL7Sh5+DEOmuhZMamakUm8Khb
EYE/is1ZH9MhdoT7ULEKDBHVS9CReZsMsU+Xwner9oocheSqNCgj2qgyZ/KKgyEuvmsrF2TLxIV+
LSYjchy3pb10S7Npq2RhjmlLEixdIRopQn/UiDTdX/hmzr5i7p6Z+mqcbiLCZXy/zov/vPsRMNmz
F/ehC9zynj4zEKB6NpGPYD83mIiUX7UBofsSC3I1CfksHksp1au0TXEp2Oqs71nvhVugGkV/AMhz
TssaZrKHa7ycH6vE64wwsROXZNvJ+Kra1HtKp9X3yguKCzSJs0XKVVfBA/9hB2ZMcT6kqASGroPC
ytNXVfwjHtLymczJZfmuVU1Xb4rRVvMFLeM5r/b/18QgGh4viosPCpaqhHYCVq4/zLyb4Eoiu6pO
pIZVfhlWcWH6wPBl7u5JMC3rbhtMbiG/aJxTy2YOVNISctTrY3xh9zirgNe7gli1GjuuhlQfVbOL
HRfT2E0POpK73itmN2JxXClT2E40Sbs6kiHTOyscXVmHFIbQJaHNOeeULEp9Da9g1+ALXTuB98sx
93qMkebYeKiwjyUTXI6ZuydIfNFeLRXr90tfqWqLWrwdiWKfu/QFraQqjxV8fT0/WikWwSHMa+KD
EjyR9EvD5N+5bn/sLtwgGwVAF6NcGkxu9P0NtnWLRZjeu0z+G2NV3Q5u0GEk1aRyDhUBNdq13c7j
dAXoTRpXaAyoJyPRuoH7gMAyGHct83gmQLCMbDboyiqqJ0J3k+4UE5J9tdScGb9aiBl2xpwYHB5m
myq7XSkSFYftMAgDCLOKzXjC8qLtn8oJv2lm6jNZSptCSs3vN2aiGQejnB21mwzyW+/ioJL5jtRv
kYeD9Mf5wW9al1Ze69N+246c5FtB2o12rOPMaaNhWNSzM/aZtS1IZR3MCNxI9LeMy037QeYEtsxh
oQnl3lfdNDubam5AbtyUeJODOWX6XltyXXvkropXEBOG7IoXSthtoTKKPD2fy+PQTLdQ2e3yPq6r
FZz6t71tfVeI7Onk1iAN8jvOzl+p1bDG7N54UI0ar6sgLmmZ55m8YSGNMqpsUZibvMgzhT/OEG/M
SaHGT9J1vqUH8/Pfb+cMGeZuTFYNwgdCFRDFn6ue+lrZyVDbzWO/xHeqm9JDAJoeobmlV6/i/Jdv
V/HBGOP6wm7znxcGwALR4RNnP3m/ZDVlSzOvZPs4BXZ6YHBVhsQZ4NOM9da98GfttaPeJZ/ezcvD
35/5vB5ZH5rNlTofYhhmoOf09VQWrIVpTh+l8tJg0zWjCMDE4Y/i0e/mkYvhgfWcjYaHr6skRxHl
6OciEOWFxuvjbwD1jpsxofoBDZ1z2TXGlq2oteFx8FjpdmyYoVGU83U5zu1et5vsm8ADIioIX/r0
95/g7FDjF6CR/80jYx4A+/dsRyukyZizrLUH34gnsSucMZ2vyRwX9saGbbgBhRmNsJYECF94ZuP3
U73frHhWd5W2UYcCbKyH/x+Hu57BjWuDrnjE5sNrgFqtplhr71k3iq1dYLUTKvz2unAJJp2klsCu
lqdpcmgW+jmwRLrJtEmQ8KKNDEoCcwimb36TJdrLBJ1oFj9nlHzqZoYnwlxRlKtbdWIGdTQF6NSv
8QzAGMBPc3MOXTlNKbO91mBknFftqVZJXW6Kjq9w24+MnkpfmESP6/qEHJBxO6ww8uMJWcEhsb2J
l9TOd2CN9bgDFdBwACKUZ+ieKczqe9eal68xO2D8gG984+4nqBfVFi4yeY40jqLbd15mN9HSuwSZ
p+6ge29LD70fdbsh4yMuWwWbQ98q/l0rFe597CfldSUYg+7nMnC6qDY1cyjDxS8Yubd903kbaY7Z
sPFGXNiisjNd5vSM4ponKN6iu69ivy9PanKEhW+q4TPbrJ0xNqoorcqM2exUTvnOayf/EfWEV4de
GrfEGIiJFqoTy/TFcUvn69qN+lC/hu4eAkzl7odsxMLDpSgqo1SNqoXgqauDX1aa+qTsuT3k2SRg
NblWq10rRYkX+lLN6dYVDGE5pqoRUkUUGBgc/GgVM87NuEYJVPtkbuzmq68Sz71fxTzLPVRgDZO6
OnW6NJoDL9l2VERWRBVnLTjvq0q/EezAotktamntTVsOHG+LN/NJT7W0+i+ta6j6Go1kQYsOIe8n
giz/vlKl+mTW8+SHJnSCapNUtQw2ZgkFQR8Ls9gsRRIcYAeBXkR6yVAmCtIUBgGaKv+YNlk8YzTm
119rkkLNUPmL+ExTVASbWVtJNS4RyU1kLgm0gz3MOYxmaqsTwV4uUs7EhTQw3Nra7wIkHU4aR+2s
lBi2jt0GxdVsTYV+5RvV+L0pSgJoUJfXcmbTHP2XjrbJuh4SnOXQXqVaw1ilH73y0BTCFBEbwnjC
NNSzn3okVEzuZ2CnbGNjnzTfsRCK8ltnUubcxpNZqyvNCRYHb2RNyL03aH0J9Q9r+xM9cu88I89I
xuul0Z0uHKfUfFuWOefjUjLQTwr3RCdndJU1aUhsd1lsp9qW+9JTtvGMeQAmVTuXhO8r6EcVceJr
UUNFVXr6y6RJn1mpgespCpPYqXc4sJpTeVvWpZLa1kkBIKNF5N3DaNeiuDeXYXbCIS+1+AIz/OP2
7DjIHqm/mRXRuZ8hjqWvd6RWWM4Dr3aBzDj402CVIZFb1hp949rEF87leAuhDd0POW15lv77UeWQ
cw1PD4epVTq43uMfm6XblQuEyCx7rCadQqEtkvyuY8ZwZZPT9mSNun1wrDk7EK3mPZBq3G21PtMu
9GNnzSunBUuUFPaVSs1JFZyVLFibTUWAdQ5x9qWBE1GVSfIUl7ad4xfHaN1Lbphnzc/v67mIvDDF
B5D8P4Prj4cuSmA4u1jko6fr6UNteOnPPsY5Ea53cafjRmX9e1GGSyAWLatgkibv3HxjlAiLGquq
HzsvqaqDVk35tIWEZIctOZXexhhSn7ipRn2qEk3smQ52UDWpam5a1B73fz+cP647XKbx6TGgQpur
6v79OyeUbAmkYchH1dYE1fSyucZpzIkUo/JTDhY/RWXC16EIY71QDn6sCziYEXDiQcKaw2vv/aXR
F0iO56Z+tIZO3I4DIcSTcoZvExBhOBcOPZ7oxePfn/c/LmrgeQozE22fC/D7/qJw2uE+uVmPB0Vi
bmB9+luBN8b1rNfpSz0M+VEy2brwpB9+ZA63Ff1BR70C7fbZh8UcA84SCsLHvGAcV5ZF9uwLv34L
vI55Rs25aZwYesR3VR+0l9i3/3FxjLPBJ8GDcBw+xzdQJtQMjUfxVHqiWDZBh5cZmayoCOSoH7wg
q5mog2jAOcNn7kIFdtZQs6ZWCIpthQOQiYq1fn1/fF256JVVTrJ4sp1U7TpN581ysCOWLJqoasf8
UGm5dWdBZyMBQxgXoKmPHzdyIpREmB6wpX3IMiiMBluTWYrHcYALKjPB2U8WLSlZUyZ3zHhgOf59
fZ1zGNhPIBBT7COR5WV/2MiV21IjYd79kGcLFNtKqy0wHNdPx0NCPWGginaK3WJJZmh9Y2OuGMZx
GvSf2fU1eS39Zq1C+qRujoNdWOIWZIZSJI7N5Yk7h7rPIVIuaajVsxX8mL1ygCaczxMheUaMn1gX
DllLBbv5+4OdD27WV7mCZPwvI93VuPj9q/RQSsMabvVH9gdlRZooAsgUsBl+TsGYPYBY2WGz6N4a
fONWz4NMSaAiRch7YTBeMvYqnU9/v6UP3zK7tcfXCA6xCovss+K+YFbcaAUKW5FnxaOFcOCg+9YS
Q6+2nYPIx/h6XNpLo9oPa4rYeTYr4pMRXuMXdPYxLwGENhBc+7GJtdg/zaNVXsdEc0LYa4L8oCCM
vv39OT8ciQDTTInWOSRDKvt8PJdq7FLYNc2Pw6SVz12j1Y9eZoh9WlBX//1SH39SMGoWMN4PFCHg
/u9fcpKkkHlVkDxJzKA/18r8ojLfPVU09iV+l0O+dTV5KS/u4w61ysLgYulIrDFlP3uPLcMpOHtN
/Jh1VnKiW/Mj3WhqCrzYuXUbzzs1xIEWIat7vAB9fvxpuTIidqaSQGGs7vfPu5hTPeXFkD7VoDIH
xE5wUo2xTe7i9rI5EYMI/rh37Sh+7yxXWEHMPte1+/5yNYuZ7inzHim1mvaBqT+mvXW35KVCfVja
3U/dQ8j+vFi+nqIAMEoAR4pvEbr1MME4XsuKNOz63qh2rim1H37TEOXTEUF9r3xSI3YWJIY2XDSR
QbQFX0qPjZ93VhEautf7YTf0JDeBdsXNpvdwSmojG3XElVJGPdxThxvDm5H5QXGbO36j01/ltjHd
YeTkI0nSEH8eBiLgMxgKXvMJm8HypRFFWsDpy3BAXeIxWbbJoDdvBhtCvqld0SbRLDprDF12qtuu
HRCYUFLrkGDSqv3pd/ZchvPQyf7G6Tvti4BrPNxC5+w+pW2tvfrV0L0Vi2GJLdqn5d51ytiOkjF1
+mvdGpxHeyqXN4i7tJ1lWxlhPgIqR4ht6iLMyHAawmJO0htlmRhrKr2YxbEvRf04xMbQXxE1sDib
mplEhPEsTKxkrscqHPo1e9kOfFVudXdakoM3z3qk+ag1PzWToQX7IenkLzKhSZ9zC+Sb+8LXVfpU
0bNrP1uTiLZ7iNRiQwldTzsnELV+igFYrhNhFVoIpNv/4r9QyCmo1Vvgjsra2j2h9yFwzfiiqbkx
P9etrI5txxF7RCZl+dtMxYPYzKkxfLE41+otGip08kB33QjtGI41NudzRpPA33c35tA60HXNvK7d
27lIFqZ++mwG9z590rTz9Xpur21Qi+zF6UTZbGL6vCnqjMQqDhPmlKAFaTWS/m3XzqGtq5JYdRf5
QDjUg7D3Dtlgw00zg5pE7tIb4yfPafL4iJPSaI7bxYwzUjHptAL5tTQhkoROk1SfBiRk+Qa/52E/
zn5qPU31ygWwzKKFF0HxnWJ8TNsYpmZAa6rB7Z02WV37r8D2gfvWtPB9N5hu9C9NQvxt1JvCEydc
Iqt6M/fGbF/j+FXWV/Dhs29DYmnurk4yjSZ+tAas0EepxFvCMfU5gW72tSyqsg01XVY7GESBcyuy
xL/pWwQX2yZWsfcK8F3LDaDd7IWLKVGKeaz/NMzmYM5QcQ3ODzb/vnsYHDXdDhq0yw10S8YFA5vb
QFhJzzwsw6H9tRCofe7zfnFXf+fMdR/9GLj/Guo/WFM7BvqB8pRdBDQgV80Q4qPWzNsuz5rsDouz
adoFPRklL/U42UEfYt6YqpBbnXWxcUuGR5GTapW1m0ZV1GHcweo5yIzFxneTl9PW8zruCGKD5dyI
tO1f20oNb4vVGD8Kg8UdKV7tdN2NQfe1wh8qu67iUdRX01xJ/BBm1w1tjPwIRulKp7zSp1gbqUiq
7NUZqq78Ebd+bwMGDKYbmYMw3xr0pPEhlwNRrkVJr7HBGRQ6ArkMTXsFHbVwgDVUaT/Aipcu7ryt
6t9iUu3y44j99vIkBqcwDlUzY+jEJEvL900+lU5o9hJFA+sRHYLPaXHA+2lisFi3OeYR6Zhj75Nl
MtJhqo8beD/WxN7gJelGJ33BvtJSLOSPnhdXWOF5JsFFvijNGOyuyIxNH7f2rbdM3iw2onaybEfJ
5gIR2oV8RaubkRHixKg6iWvA2g6/Kduat5ow011FAeG89FY8DDdjDJAWlYZftXABXSLl7cR0P6m4
QYwV2217M/CrDs6mmWHgnyyZGsvOHIEnQpvY0HI3OY7cis5kgJDbqIAjyL7CfQxcxvoFwoTUdqOp
ybFjMuocjmxVz0gIRmk2excV6s98ztTPRcjqBTF4NxzGgBd0G/f4lyJl0BcSJrNaA4b3nO6bHCFm
3iJB8UZqKZI+o9mSVnqce13DVibti8nbIMSqzb2GkMt/SOXU/qpVIDTc6Gvtp4aAfURMEDjNtrFi
75InzEdUne6Z4ZhDrbt28OdDKK92TRtpTPzk1FXbACe6PfceMEUMBxJh652qM/dFLb73bAN1ptik
q/qOJAb7ksb8Y1283gquitRmYFiwLd+f6Z6DBKURY/xkV4PCSMCubn2/kQhFib8EY6+ynWkQWa4S
Pf6CjV6B0XRrfU3nwXiU/oLG919LOAS866+yDjLp6M+qKdtSNsELs/XI1Du57lJHyI1u+9X95Mzd
4wh/DDFtPagLl/1YFnNZSA4urS5iU/2sPVjarjS7RFmPigAoPcSef8cG6t/mxVLeum59obP7WKiy
+yE3InYBVeuHNgsm4lxZZmc9Qlnrvk6zcEJdJEM0QfGYo8GpukPT6MW/oiXMql0sF4HIVserc3Oy
WkIuEWNaPDkDxXeYBA3WEXU53iEK7RFrz8Sv9kyRUKuREH+hNv/YS8M1wg4HJg3N5QeaRVayoJxy
9B8HJdHuQDiETUuISdRaTtpthtzODt0CbBhJBAiflYrNS9jVf9wChDUcCGiBVk+Fc3AO1Hwah7x6
6qdcC2eVY7anjMrywoQQUkbBSxUmuvJeq0ALRgTrzqWElY/LDKNcxlekn+Jnap/3CiAp+pg3XvdE
UW/tGZ6pHrsewz7aiageO7OtXv7+OZ2T+Ol7uSKSEnrN1UTiPPnXk7KHUzY2T36SptNVpyr/Km1w
+Njg7un1RejIzv2V5ORLg6hrGqJjDn6j0ltm3AM0WYJI0NxGRcahtXUau/xpeG3LsImQ7D5ygh5G
I/bv6tqbszK4sGg+fidotdZOlb6KBLVzJmviehDpjLR9KrH6k5TGQ7CdCtjYmkuqwdZ203HDdtEW
F7aDjyuF3hgZDpM/mAys2fe7YtDqGj9cL58shMR0EUFbl/t+8FEfLeQ4UNz1vTKjbJzVq8qHRoVq
yZPpwl18XC106ebKNeVrZQxpvb+LhmlPoWqjflrQ4HxvuC4EwVShSE1rLUJJqV/9fbV8uGCwkkmJ
pOFACICdzmD8Ru+EBk/bfDIGO7tpFCpKldnOkXlXc0TxMf4zKsNcH4yNtcn1mDOfdZSzxQDIZ8d/
NnAquNYZgnwZ8I7Gp8BB+YV3FB7ODRwmICJzmY9JYtCQ5AH7g2NK/Xs/ykv2XR/ePHZBzurb+vtg
BuJ9/5uTDhg0rZEWzF70dgo7T/O/9V2hvtrp4lyzfb7OTmcdUM3rV3lWO/If3zkmfRA9GbqvdQFq
wLPzOJjN2CmGon3QmkymR6QYbXHvyconrzEw8XP1pIM06u/v/fwz46K8eQSIaMBAes+9Y6ukykpR
+P59jsXFj76na953/F1zb+qcilt3KtthZ6myaS8chOfgCScCdk+wxfAmZCZxviXrZMnZtsboAgJL
8D3uS/dG1othbwXJbsHWWYT2pcBpwY46t5vTC+v9nMeFByDyIEywEJ9B/YPW8f5tw9VrW5TOyUNd
NdO3ydSQxFZLKSOrK/IvqIf6fWATAxXUeMBOdj68YKO/hD4F+CXs6kNRyL2sfpAYUK42xcC97+9F
a2IyepjLPxhlNh9XE7ktXZQ4xJgtnSwSnN1wCIIkxhCkK/f/o+w8muNUujD8i6gihy1MlMaSR7Kc
NpTta5NTA0349d+Dvo2HUWnKt27ZCy96gO7TJ7whdOfssxRzaBze3wtv/A6yT2rQRXyTnGgNaE4T
zegH+u7nSarlUUxT8WCK0aEOBJz0S6Dx9sMxx/bZKF3lNw3KCN6vdePaut4WNn0tgKAkyDTn1v4P
XgbbPs2lde4lw83ALvu0AtRvqi9C7cxpE5t92Qe4B5S2jzB9r2/ffwnXB4L0AKoqcgZg2VHIvfwW
Paqf6dio47kzjOKcaWOxm53eQzm6rPa5MShHXtGty265VP5ur3G/uRpyjYv9GdSt9agjVCxD1kXU
n9tuxq/UDkuv9ofcUo50dtL9+0+4DvXLMrxb0kHIOxyBVZxLwAuIptC0s6vmfeQj7ECvomjDP8mo
hrsIX9cbV/k6sL4uCJgDrJjBJGftmdIWYzukEI3P5jx7h1HO5Qc7HpPpAcCFPLKPs8/MsK0tPVyH
Ezbn8b8a+C2/gKhO6gfKGqbI6oCZ1aRVQm3U84zwVLij5yWnh6iPtF1YJpp2zBla5v84GH9d04SO
B0MDr4L1RkpAlhRtNqlnK+qxfre6uT3QWunNQHWlY5zoIhVf6QiGRWBWYfzf+x/5jXe+3CWEdMoN
So3VE9tdw5nBLPTMnVZ1Plwx8aVeVG6zDrGfA7dXui9julRA3Z0ghKF1I8BebWljAc0xSfKoLhlZ
Luf8rwEaw4ZanbCrPs+M0rqNmdSKecw01MyEF0a3LPXWtJQlYyFRInDpPPbCBbtcro1LxJ8gFp7L
FDW8TdNIC3x8V5nDieFoV+37NkN1owjjzoDKZwPIrKxsVH4CIzEMOtZSGoe+BGEWJV6CXKsn89zw
pRkDWwoas26L+66d1NpBPdOKd4wdUyuoUou6sXZ616/1Nt7CT0dVxp9tsKx5QP4IDle2MS3xpK4l
Ghijm1ib0VrKoA4fzcdEjukt5/UrJO7yLqgy0J1dEhoKvtW7kElXMU2yzziP0XKS1TlFCMqEj4Iy
VoXPtQziJHfu+wQ31Xbshr1Z2+WP3o2nr4i4yD2oUfXGvOL6boHfscySl91oLLpilz8qNnVpxajH
nLWSZvc+USLhnXpFL3oN44xS2fPCa7qMKEB427rTC2UfEcWSpxS/71uqC1dBnh+DDh1IYJLexZLw
8seAeovFPFbzWdcX7y4HsatNMo2TDByttrbQcwc/zULjRtL71rIwdBfhfHIed51zQO5x0F2ptLOD
4Il1VGxhg1KvYrrWTVNL5dQCiNq1TdfdwJG+cRi5z4gCy41GDb78+1+HcRQQEEH0qWdgaNkfW7jz
JhaKLoENeWpz4ynXJMTlLIJbZEGqJzL79W3GZVd68yzVc9jN4lsEaqEPemqPkkZfHm/ARszpPcD9
YRP3taNvm2hgYKGVqThqoItPrnAm+RGdGvur1HE78xtlth1/jIS6EXaXTtuhZhrx3APNjgNUYhJn
g6ZQc0ig4kq/yurS22BUnUMbEXJBvWtTl/goWEKvv5G0X6UrPCvRjcEYXACGW6uzpqUGXHc5Guc6
9aItk107sI0G0S1w4PWBFnNe4lNSOH+UMjZv5WtvfFYYLK8vmRwe8bDLz2qCmMvaNtTPyAsnLV1T
LwuRU3VnKY4TEGnjuZXpsB/h7KO6oVj4eVFW5mjhWeo97sbutI2sbrC2sYLez4cUHbvHLEMY+8aO
WCfboLhpQEDGx8MMjhMV1uUPzdIcm0fQ7XAn86z91GHk+5jmdsPwh8FV6mchVit39Kbloyjbvjwb
1Ni9r9HVjj/DqS5v8GRXtyOJAIk/dKNXhC0D3OWg/nUeyOs9vOHG7JSh2iBwTgznbA7UTGuNDZxv
KkSfs1p91hO7HDbDBEHOT5W5MG7kCFecfX7Ia6kHl4RSiJB0+UNaS3jzaNnpKQ3NEa/Ishra4Wtl
AekMGF1l6BFOjmAikbQMvv2ylbaD35zWnSYg6d394IrOigFMoumjcU1V5HS+0nua0ILKKFT3t5lE
I+JbQKFOTi2mHFmPqCoDOwQ+/d/7OccqvKlAdVwIQKDFqWK4jVdvNUZObuiiUD/RQ+zbL2qlJUdG
vYO2oQ1Vp30A0SK0drOACvLy/tKvqsV/ZdCva9uLlL+5KHFcOQWp0kMksm/Ne1TmzBGeAOjUENWv
BGo4CoXFUHxKayeO+S2of1m+0Wa5TII8HETb+k2mdyOz+zREZrWzo69QniFztjJyrV0CqJgMweqy
+6JXgfzqKPIBawVwrtJEzAvlHuBd8013++oJCGijbbLC68RJCRN1GWLpU4EvosgYFSZd0fpxP45N
oHml8diNLmrLeY9/7Al5IXHnxqi6bdF6jLrAkCBQmXixC78WbT+VuyJ3xw/oVlKKdJlsol2kafX4
Amck+dxJALqbDmW+X4oDnOVUtWYMf6Wt3F9uUiDmURRC/leEjER8EqmW+gnIfrGvMOwZ97aj1Pd5
ZSHH2RU6TQA8WpsDcmkQLZwwBfbsI7WXuKeazhzE3pYW/g678cm7Z2yhNPuhcbRjVntVwgOactq+
/4VfM7jVFwYKj78uVZ1FprdKIAp1spCqVeKTLuouPQ5dWtYasgJIIfteW6fHWB/C5M7qe8Rr9s6A
9NQHNGDCE8G70/HD7Kq0RflQV79YSeM9WvTDkYY29Zzx/6CDGX1Arnj61NQIh2yFZ+Y7zyA83SEz
mj1nc6KVe761Ch/ZssWcbcY2Gyd/VFKUBAMtCXVA8q2Zv143jtvRt/JSJFDffw2r+4Z9DhGBJh2Z
NV1RzvxlwOi1cWqizvPuHUDYv2vXsfb2nCDIppnhR1WhwPQlgxRaFnHp3Yiarya2l58A04ZXNghD
GviSq8U9Z4pm1ILd+4GyBdJPlw6g61s7LX86cZVGLxQYuYNOlqf9oIFiJS8tjHD7p+UOCWYDKCzJ
wFZwL0XEo+uEX2rO9GgAWZfanZZmU/pCYwzwhp+7uUSDMrZq5TO7a0aHyQqL6CFsYjXZII/otsNm
hvu0gxmQeZ8jLfYe3XBezJcbTqeghEalhgzHqx6QQq2yQzuK5ueojYAJbpS3r+989VoYHkFDhPfG
pGP9WmYrpdquVet+xBezgqmOXp/3oFlNvwXg0bQ7gzp3bxVpme1jSym+mgqHnEmqazVzjbQU0Pbf
jYjt5E6l0Zv4ZafQ/PJEAzg+pSVU7jDlsZmgRpSPJs0PGTLJFW7TKduKFj1XZwkXC8pakXNLWG5q
Nnuw8FGxgZnm2d8tDL+0Z60Z3eqDmyVRu3HatOULWu6EhOSYJuZRGLAmn+nHl8bHDCFieeognwJ6
iMe5DgYtmaytCS6B1LiodQ14hjuXe1Gq4fCMlCOvld/lnEWBDMADPsPpUwksk2H9aE+ihu9eN+GX
KmXYRaSl3p62CAya2FWHBroFLSdHeQFXSMOrK8cUkeEGDkFoglVBCsxbTI1LpRZ/kiRzkdurKSA+
v3+0ri9jIL004JjOkaBf31/AKBwS9zQ+NVVi9v95ctC/Y2zgyj02oFGNk9eskW82Yak7PjNKJ0CO
Cl1WyOipBYrBLhH5ixHvngHraGp0l2WJNu3nqLJAgAxeaX9J0lm8TEo9JA9W5FbOoQeZaNw6p0ux
u96QDkNmuLgYJYDUvgwSSa5aCHr02r3EvE7bmBV0DwSoovzX3Opl/iukSKn8SXWUR0SXp2Q7xQtv
VTqc5E3vaHEkfBFOrf6B/BlHSfEKMU9FZ7xESM8vSlvYxivfq8SSznMUZ1x2ljo0BvfqHMuvdZs7
8a8mlmJbLioC3tZrWtMLvC7l/nWjeXz26EAlkB9ACNQxyd+NjPONMMlvMpn5QQxwYdVfvgGIQW7u
Ft50bwN1bOEIef1HQzGN/gPBQ1fvTSFBLXuyT9oPaafOyXDjB1znQoajIcNCFU4MvoJrM8AfGS9J
7b636aN/yDo1+iDMvpOBlocqnYK0QKkJyeJZ7N7fxquigBuCFAiwNskY816A+pePHucV3fa+Sk+o
QQ7Zdu6U8jzqOU5tqlU7N7bamkK/rGbSuSTvo6e4aCZdrtZZqjA6+PL3WlRIgbiZGxnRIcwXm3Eu
orL62jdo/weDMdRZgLiRYhHRFUXbFWqn4/6a91M73DdTOu5djK1Mn7pwtolMDq1WtutQ5Gjoll10
4zVdfyB2xaLfzvQfT4M191/VMjeNE6ncQ3N0tT2yiyrkyhnvo6cKuga3miU/az2B/8bCy9a7PJxU
V/QcwNi8Cj4u//5X7VEMjMn1fo5PiBzWw4Ypbn8wVWAwexxI5kOXjdqXf94RQPf5OKga8ueat8G4
qRqVLk1Obpz2IxhNmhAvah8hug0IabTkrWn79ekD4IAsD5EU4iY34uUjAlfqmzhN0lOXepW54+kG
cyNJm8OPZNBu8uiqoVaDBm3jnz02Pe35/Qd+4xUvMl7gLBZpHPqBl+tTVTkp8g3efdOX6d0YLt0D
biT13DOJ+aDn4SxvpGWvPY3Lr4p4xSLGgDAQ0WStmMdQNa8LNXKocDUHmaWRGcYZtp9o7xW1Es3X
POqSNshGAbw1RpuNAXppxe5HLZqKb3akRSH60xKl7GeIrUi26upU2LcgNm9ccTQpoL4v0kEIbazb
wqoyOLVni+jUeCGptj8pMpt/yaHrH5QJKRBfFAkUomxBRmR5XD8u3kqLrnIXao9xWXdltIOApXQn
u4O64dt6ESsPXpnboDkmGHkHZTSsn0qoKSLZ9HyDchc5hYz+bWxJ2LFM5v5wQxjgocawCnJl39Rz
CyrqVI2adpdGKTgAqSaxckjiXOtaXzFIKLYQPsv6FjndNK9OMERkLMrJFoByEG4vt1dhWGmWjalz
P+RD/RGHSomzNeBB1OHtEgyzUw8RQWvuVBeTnS4MbU45o27+1Kp0YzlUURIY0PQ8oVYtSH76svgx
m8ALX1JGtfNn7BF6UJNK4lXfmmYyDpadyShEzjJeSvguQmhq67lIPwbjXJSglR2nabft4CnjqdFg
VvwSjVIn4jEe4rYVNHhkWkb+VGcVw6tB2qVzGg0Gyp8kNgZHdNNqc9cWaMn5XBULDhtvrtZHtLX8
wVHtyWhgOtpBRMv8+2Co0ZjvzDpfpJjeP7rXYXlBRS3DMMY1zC2W0PJXdMyQb14K8OjkEqqKjeK1
VDRuPKugo1tz2M+t7W4yNICyf18Y4h6bCXQe2Is1DAydRkqoCAMJUAJ9RumBGYKQccVPUATowKJI
T/TibtVzb9RUi24KszGOpIlv2+o6cOKC7FuG8/2Cz3acQKTSFrsJxc3cr3JX/lbHOg19iQy7dxea
7vxBdGXZbcN2MBWQ6SYSxUOSuvdpOrlb2Wmhs/TQtHA3e8icw833CkS0VZQhv4RZhhRV2xYTpXFr
au4hpPaf7mNvSu17OVmy+5FPiPg/KA7qS09zY2Y/5NjQolCaAUkXK0SfetgyKUCwftOaWVjKDdpI
t6R4X2+Iy3C6qAWTv3KBwEfWV9tgaf87Rql6wKKrFBIz83ixMbqsnJ4ahGY+c1TICBDW8D5Rz1Tf
kA6X7riBxDu3gJwZNZT7skyV/wDDoqL7/h5949dx9g26iMjnLoSIdddOghyIQxcmb97PcAwRpRji
o6kl1EbenLnOPtKq9sMQ93b4otdjQT6N/UbSoCoESfKTB4fX2CCxlJg/5FSLxPznzUyzlcwG7hrk
Oc7R5SnqHFqpI4zbk7SG9E51U0gTQlDgREezY6PssSLGetUELF2KGynh9eW7lME2MEN9ka1Y4zqG
qZsziSo8zg6t+wdPFxBSjkgOwAd6YKU2xhK7G99juc8vdwttcEYODJgXG4I1GUZ30lpPQ704WSM8
+fs+DxM0D8LB3YukPMMPmf9kqHf5SNdOn2wxAE5uBq86q2jX1cf3f8xVa5nLf5l8LvQuqDLrV++k
Tg3YuaFBa8/qEGSuji2Q0JXiSxQhqRuA5ULdbafVQF3vksopf6SVZir9jZ+xRv+9fnn6d6TmUFWv
O8tA0txaz9vulM5SmZIASLUqN2Sm7ogIjTVq5kcLga/HHoFYJUB83srP/dxIrHIYW0Lx8AdjdGP8
GFQwos9NNUjTRkIh7JSXNlfM8EwwVOJjO8NBPizy2PHHGUizfStRt682FHcB4HPEdJELWLLYy82c
41BQGE3SnqLSzdLvTFzi8gn4n4uAPMPeOxP4YYUQNGEbcVH0+mBI5MnwWURDtktsBS8Ori4N3RKF
NniJmjG9s4DQ7nwLofqXz8D3yyeV+R+iFvkcfg8z6UR+Axk/31R14b4kDvWU32gTtw6j1NDZa2UO
FQLtjyYx8w1S+eZwZ1VZAr0wDsdF9SB1NaXbdPg5FYewDwsXkQXdir7bmCTJjalkqrVlSlyhqBPG
FNSz3mLCY1llXzxEVm54DK8983s4pJpy14263T4p+WgvuZkNbwKCkQtmWNOTQ2eJhIFqBt7j2HM8
Gl8bzK7za5VR9labGaUcbaQ9w0M8akjnWblOaofCp2MkTKHn+YedMcF/9fSto9oPhYD8kNuZC/iu
Hdxc+WKjuI3eQGwIBIPfPy9XFz6iUUvhSOYMQsNaj2Is9OMtTGKik2KXWv8ztiQkuhD27R0OSApi
azFZx4LpuBXEr4oUFuaGYVjgUIkRqy63VRfXzEBckObTvAArK0uJD6096M0fDBaS9i5ptNo5CASq
q2Aiov20htL+NudNJjpfHTNv+hZZVFGMGlPGlES5pCr7Y2ZjU3AXmRr+r36H5vPPmJvslt/gGrzP
8QbPzTjtFayK6vgK76CPGVNFvUxPnkLLZa+lk7MxJgvKhyHCE1MaNOux8cWJOmTity9o28SBmWqG
72SZg9EFMvM3Wh7XUz5+E8EPtjIBB2201a2DpobaibwoTuz5bsLIxTRTIN2VcE5tBIMpwHCFdAFT
EGPXRo34WTqh9w2mGXaXilEN/ef3t9ZSBFxcC3Bc8d5jQEtuxc9ZFQlR55BMgUI9mXZd0XxICwxI
4tZxj6pN5vz+Yq9k1vVqlD5IR4OrosBfJQU5OUue9RV2DJlbx8jlNngQ4eKhZgAL8TAM6PkmkEEr
MxexDKZ+4BVsXKTagGYUkdLIj1pi2eU9iXaEKii2CR7KxSYNksF3q2gu4htH4OoEuPA/mD/CvYTd
yY11eQJQ3GQ61w/WyRkRiOuzynl2824Svg5p8xkuOAy6AlbKYylj58bk87qIchfxCoYIKLExD1h7
mOMhjow1nOQTG8Yts6PSavXnzlQrHHIGN8J2pHOMGMxAWYMu17dW0qZW6I+TwKLGgaIHJZTPAUWS
KZvqx3h7/Iw7d6o+1PmQifOiHDTtYUfmaJJgbqUHAn3g89DIkQ494tlGHLiK188Zij1ZMj2rqmK6
vzJNZL/NrExwbtITmQVaYUxxoKPG/ymB+DX6ExJ1zhZTbbiMWAd13n2pjpWOW5dsPehI4PkTkEGm
3ljphgijaJtJVcvom95X4jSkMXAHPwfkaPRBhAnGeTQ0iMM3duP60iQyEBU0lEigmIDzW12azPto
ATdqeTcKWVmgk7oZJ53ZUffWVPZPkF6xyrIWryTylfvJ6osdVMHqoNY4UBGq8fDNivqbVWHSlPba
YPjYwt0qftaxn54U/y2FD3kiifQqBMdIJKew0MUd9Hvr4OZ58l/FYOAwwUbY1rpaPebZP4p6EfkW
CIxF981demLrITU9g2oIW2W4yxtUJJKxlkGo6mWATMBw0MhE/MRw5I3dvo5EhAXAeAA7SchoSDur
hlSd1pC43aY/lOZcfLIchAj9mEFL57cq048bH//q2y+rEYYwWqfxDMT+8lw7nafgAK72hxqHRRpf
ZaL6PaJX9WbSxpi96SF79Y8Vx/KES0sEEAMbDhOVyzUjXQ5NgwvHARC/9QVZJzFvajfKygcThBvu
VYrIPxUd6dWNhd96tVyClIjAShZo2eXCSDh4WMlr/aHqWrFxBquad/DGk9YHNuHcak9cvVr6vYye
F4OCZUC01pIQNmCmknr7WJhjvBkzO916BdpMWGv/FDUlxvvH+LXd8felgpkDwgngQhZA1eJqevl0
feENEE9n+yBQjc6xT2qmqAf+vKD2P8ISMYfA6Wd7frSTqb4TmVLbpxzPjvpjUwhq/WbWou9YyOgJ
6l6KgjBbZ4AQSeH3KBvdTq1vrparPxqC2bjVJ7SiNvZQpZ/KFAbKlrvO8w6JW+pnNMjQysxKdAdO
pfDs4eAleRG/eNOMAteu7EIo31s2nBn+SqLC0n7EjNAHtvlQdfMQNGrf5b8EPSc4801kwWMuUquJ
kb2s6N2VZRJ2QdMX/S8dRbrkXkX+Ld/hh+NEXzJK7f7YguvaNFifRUcc5WQTGOZkEcoJsPppIPnd
li74r0A0BkhLfXBk1YBwMDSqnjKGhF5OUQne2ZFSfHJSL6t+v/+x3tgb9AM92lYeSaW6toNVNJP6
B0mB41RF2vxJj1MNLFqh/h5GMfcP+YQD/fsrXu19IACL9gS9I9IYay0A7yWSFM/Kk2MmtPwBFKom
duAd1e9K0iXV9v3F1tkCW/H/kxJD5Ua5QtgWVdXRu5iA9OC2adDPoFeIPPy4cUPcSYFz1tuyRQ3M
95TiFjXmjQcFUbQIgqJfQn2/ylSsZHDDAh41h3wMGb3q6l2k1cYHc9blr/cfc93c5TEX0pWLZjip
CaKTlycuxyOOAk3YB+6RwW/0KsWOA4Oy9Ma3e2MdbOwJmQ54UHC6q0fSvBZt6CpxDxGiC+YXqcrB
uiuEqfa3IuTVLYsiCoodkB8R7CeUrCJkkuiYO+BWcwCGHj4y7h2e1MhFjaMo6xn32ZzxnDfI/MYQ
5vqb0UXFtZUqC3btFbSNAji2rBrAv1MgOrRzJnCjO2mE7QepMJB6ev+zvbUaYlGgUmjf8kpX9w+D
pqLy0lCBKuWm3YdJbeiWm4AqHqai//7+WquD/opv9Rj2UDYC3qPJdblFtAjjGQzQtbOYHPWzXoZp
GmTt2AdE2LzcCFckz++vuDp7rEg7nIHNcrMuIk2rFenbqUA7hH7GbG2OHvtyal9iXcmnzehIrYMr
pmrfEA2Oo6PhtObn91dftbReV8exmN/AMJuCfLWBpk4aNT0v/dwvmuftqFm/nNCSgVIirKdgo7mB
vOvt2pxhfqvY8+H95a9fNw1gmtGUvIsQmLdKZ3hKE6z4bJyjGv8UWdXYUlqF/uIh/6sFtWt28/b9
FVeb6fWB+QPNIupsZG9WZxMlyN7DgN08h/jKjEHmmGiaVCldAjNp9I/vL7Y6nv9fjFkphCteMnXY
5W7Cv0zV27q0zt1ET/lhdDrlD9IQaBrbhjqyk7OYxKn7d34Gatiuxv8O7Dd3/Yy80lTBYd4+M9/I
fioKaImArotzZyJM+Y+J/uszAnVdlJk0b1GfunxGHeWJoQPbd6Y3SkqajopytmWoPiKlCbAmhtm1
qdp+vDElfIN0ACcEGu0C8bfJh1dRQY8TW+hVaJ7raPbmYDJR6xd979SBlRjjpiyL9r8WTRko+AqO
sLMVbeF66d/e/8Jv/wwcpRa1L4KwtvrESoXu0ag45lkaioaEnJHtbLSd0RaLSuVe62L7zk6n+tcU
J+4DsKwQkmlyi3ywbs8sHwGMBleaxjG1GQBffgScybuq4frjI7R9c9QmxH32KGZEwHOiBD0/CQTt
45yNdgnHJUOXxQOKsQSUOD8gQNFMN26INw42GntcsoxykTVcixKYwizzTGTmuSkyoG8iiXdIbevb
1PGyUxfWYvP+d7g+1si/kbogWc6qzG4uX0Ccwt7B+Tb8ODfwDHCGKeovag78vKSnIG7EkOugSfrA
+TIRnCeZWBMDvDCLlVqvs7M21mX/2Il0NvZjO8iNYSsxNp5uIp1NGTfNNxuvm6+eKhG18t9/4uvY
wiCJEoLgTUvuSm2koyOoVNZUnau+LX7ye/ogHQZDBFlVuPM+xN38Pgtxo3l/2asPS5xmty9CobR4
kBe5fNEal5KMBjQugDuM5Y4Zrg+P+ogLWd3uaqbTNx7zej2GxqCCF+Q3AN51M7RCun8CBBueq2yM
w2Nn9OUnswaFhiJS1HbbzBznf5tygTNnSV7o0rgggq75ZiVi/8gwud65tbq6P1aeleyb3MGxt7bK
cdirs21mN17ruun7uujCmKYAZWddEWtim+lGXhXRU67pEY40+G+Jr4gxufOnsR3NdCNa8so7vfHy
D1T90IgnD6/NRZm7GI9N14hmKwc7Vm4crKu9jmwRzg9UPguR9ZrrF09WDZfMOxdO179kAocndJ1c
pIWow81H2WSUmExD83MJIpGK2Ulu0Mve2AHQ10F0YXsIZ1hdJUhSK5rKmKboSWIZdadHif4trBCW
dDsRZUGm5dGtEetVSsYzoyUCpQ144aKaebnHxxALAFRPvDMK6rNyXxl5ccxr1+U0j5htZ+5cm5s4
wc8zoLZnIvT+EbuKZSYKAUj3UKDAZWPMe7l8rkmAYohqPcVAc9LdkDn5vkVwON5bTHpunK/rZ8XD
d3nOBW1jMZm/XEwaXVKGQ5M9pYrSHWuwrZ9mqzG+Q9D76iEPt0NRExQ+IiCoZLz/nNd35/JN0V8l
DwPoY67XNirEhh20Vp/SNrY+I3Bs7vGoUo/doIhvdmxVyNYBc+hCBSDNUCZ/RgSqbhz2Nw7eonxM
iws++KKduUoISxsDH6TXnbPR4oWJF73Rdc/JGCnWIw18ZAGQSSd7SaDPL/amoxIeTKXMRl/Dv74M
Jj3WT2LQ5/nGtn8tfP/qDxERUG4CjABy+bWbvtoGZVfppXQzjyyOq32L5bXVbBDec6SfC3XCXBwH
5RDz3Ejt7127TZoAz5x2G4MBiw4u7izIeqVDmAaw3FKE5qqx+IIXl2vcQbZRTLrZE4qwKS38Xe94
4x8ax/Jjh478/ISlXT0EzJGaehtDyfh548uvpvqvz4ZijocJKP1EDDgud12aZjNujpITZruKwB3O
cAIbbVraP04HPT6JEPzXTBQbkNu5zycdqLUjspOjylseFFf3KK+ZHwK+zzZRalg3qnuuHceGJH0G
cWUxz82N6HNka8LZtuoQSb9wXdBVkS3S5/dfwhsLc6nRVoKkRi2y7hLYqOFXISHo7FlCw5kFmspX
WveZ3COFjj1YNstPcRQr841jdx1eyMhUZkMMZ3GQX3eWCAS4veZj9NR1llaggq81AUjqRsNKdExv
dMevM9PFZwPNVnoTFHnqusJzayBNEs30pz7Po99gedps38nU6B4HZfCs7YRQ0mL9YoM7LACNVs8o
Gyn1xtCyxti0aqPcOFdvRR3KleU6e8UcrAsHJYpoHkg7fkqG0nmpuc0f+kqFMaUZyJtmXdL4TPvG
Y1GYIYQgRY4A5OJu//7Xf5X5WR3vVzWMhVFLV2uN3AVFi6lTF3nnQenL+mgmyuz6GDHoWAHBKJy3
RVJJVPSSTCCcKB3ra2S1CB3WOIT0h7FSyvAlNKYu9BUzx0UXFHYMzLpxHnXMsj5CZ4gLP6f31ATh
NJbPEy4KVoC3vNU9oE82JX5vFtGHOYrz305P4kGHujROwkPTdRdlRpo8u2rSxwEgCxeJRgshMdr+
GcrcyB6H9p2miXxr9eAVd3GtJFMQNgAj9lbVKfs+d9GHt0KcBeDpqqG3QfCmSn5hDd7Q7+7x1snS
yUiDVrLvsRRpW8wTLa2N/QX6CM7HG1LVJ78tP4Ifl9Opg882bPpKiZs7VZtV44dh5eZ013amPm1H
vLiwy4jdCkRh0syPOFUa32uv1OAmZWny8v7He63q1h8PCXFuDsTsICKssmDZV7mlN3Z47sxy+m8q
h2bex65i2wDZ+sQMKrwaYMdMMPn8onWL/qfOVRZh9u4V+S5rOyF9IZvuwUSYNfKlW/W/0J9skiAL
q7a+kVC8DkpWP3eZ2WvU/NQL/OTLcJuUI1SPyFPO8VwWcgOdEjZVFYWTytpWHN9LXebNY9S1qrtX
gGIJzHgGKpm2CKXp1yiiUlSJwZCNr4y9am7Z2j3zoDaN/HkwtJ9zqLIPjFytf2hDmj07hZqaW9Q9
1XGjdWiwbWEJF49Wjf/4VgGTwsJtAWkPsVC9YZfLzOQvJFmOecP78utYTs22A21w6/wvGc36ZUDN
pUYEmrnc/ZcvQ6Uhg6eRF54ZPRvqDy46DEZ8APtxxFxpqs2vJRMt/G2HqVQfYOh6d16iKtUdhC91
sIJQYu5Z0fW5VcNeJ7pALPDFAl1GaKYSuPxhdueYlT0Z5VPGxFs8GiKev6WwWZIHgMHWAcmJ9sY9
fL0iwzXabiT2TE2hEFyuGI9GB3rCK56gjekq1j0MS6fCkcKP2om5UHULifvWgigAEe4YKdLJXf79
Lwgw0CY69GFbPxX24B64AbFhmXpmwzXIJG2vtmHdHt4/q9fXLP1vwLfc428R6fNIKbxZ6+snNMRb
yzfx8m5zY9aCvijTwOgLpCcFE6kby17XTeQ3y6yIrt8ivr/8rL+etICW4VqJUz4NXhM6DwnSy1WQ
emPzH2ZEsIWZm88essnLuHbG0tcGvKX3or9x2b/xwjnxVG/MTdB+81Z7Sjoy0QUZzBMSYBjStCDT
iIfxN9uEDl01VX0jnX5jPYi8zFcQ2mNgtq5dujEaFFScxFOFNdC+qMLvUOOiE6Sldo8/Yfz0/sd9
4zLn0Zifsm3QXbwyyiwRHBqmyWieQmwdtF06xRBfXJTIQ5JkY9oJ8o14S46j6feSfjKXkqzy5An+
VJfdKJXfenZYOITHV2zS2uJURQIFpwQpnqIwHPaRPtcnI9OMGcJq9YjXKwji95/+dSR9GcoWBiA5
JKcYVa21GgdjJhONgR7IZGJiihnGqvWTBtnoHebaoZeeil4s3vERS6v4B4EJhDD7qKIHW/rku0MH
cqpx0chWS8VAz11zoIyj34kBoZlRYjeGiR1sVKploPYzmIaeMBLDBOuNb4asMrmLhVrG/uCiNw1W
smqtj97o3DLofuMML3AHpuRgjjlOS0r712HyzFQxRrvLnxrR55/UOLd30LWhEKTGcFfXc3bk3ju+
/3LfKAwZhyxEEFJFGxLc6tIsII+XIpydJxOR0yc+JxAEfTS+N4PQ97bSpl8YA3e72Ot501Fk13eN
pil6EII8KvAr1KZ/PltMiXRsiLizFiXRVUiZvC5xWrR+n6JEy7AMnmxrW2C4NQIEdfVTnSFidyNz
uN7SSzsZQgwDjEWOZPUOkFgYslRmzlMOx0RBXB01W17C9JKkKGpA+hTjjdTqujphRQNHxP9Rdh5L
cttaGH4iVjGHLTt3T55R8oalkUaMIAkSjE9/P+puNN2q6ZJdXlk2GiDCCX9YCn6LWvD7Tz1gGQJQ
jRHzaJ6/JamyV8U8p27YyLLffPyJL7YV35Zm39L6ojlDq+T9WBZBdY1P6UTP1HQeI+TpcmC/EXpB
PSjVoz0D+99FRZRfa3tdTJJyJiguPKW4lBclp/cDgy+I/Z4w4MktSu1nXsUvisA2XZuYpbTXLonf
H+ndLYFcLAJNyyPP3czHfD9a5OSSRUgCniJv7r4ntkJqBEFxYM6v1Jrasd3GUHt7NDlVamJEOOSI
bsdJF9ufuL6K4Ct6eVqrh1wbcjqhHaphExG1WbF3KrfQ37hUWhdRn6z311UOwu+7MiMsTZ1oBi6X
YVfc7NEsiI+jjsMiCFZFUIle/IhGO5zJl1hZsX23iL/mYe3ApuNrG1lnfacKB0nkOJr1RDLTU6Ms
1kC/tOmI/Yh5a8aidboVklQ69gK205mkzVNgftJIRHnt6mR8IZHvZ/wdbaxFHWFFW6xvmiGE29rl
oZZF3hevt/q7JWvJ9w2oma0zjIlay4zy9nrg0imQNgKuGcaajpT3asCOUf8E81XpYU5cHa3qoZkf
fU0G3qZwgv41sfHtXPtOpd8LNejPxugYkxs6pd1Hhyxjh924SewD4k0N51H4UVsid1gYX5wybyfA
6Ub0kFUjvEqB6kGzrixlvhF0O9bnkrumOlWxgw0t7D75OmOJ8r3pqBHuOt1oT1xaGno2UNrnMM+r
KX1pKrrKFobnXzG8lI+pHctpRbMsehI5VbflCOQr0VOLXFeyaE8IhFfZKpUjuxOHgs9RPPQvuZdH
P/o8MIqQFkMpDr0Zx19rcINv1F+NaINyroyfUUeYrZXISXbCAkkOa4W7kyruSquPhrtMH6pXFHhI
FScjo8YtrSDB3qDAXAVdEXOKdxNF0XqdBq2uUNIv29cZCo1/Sowkk1jx+TgNYQYXJFsy4di+9edI
BY8gJHA80HThnnxzGj5R062yLaT08kQs6gerxsWRhKcvQRVmSif56M6lUhuIW7EKs8ytcZsnAfGe
PPzjvFBHZOc/x/Oq711tDvkdk0rW89T73WYG0H8EdS3M0B70bniefNh763nGS37TRLl84/qwW2Ja
fZhXVeR1xaeOFqmJH0SFxr/dt4b3ggV59DrY5PDPMJPH/uTruSZXXt1FyS4RGPJSdZr6Zh3JappX
NexTW0F0cBTbnJbi90bR81m1dPXFJsP/cjleMU7HaaqMcd2BKcA1cEwMEs6g7nUAPTTPVpku0Th2
zd742peYOnwzammb9zFC5d2zxfJ/pUxV9a924mEUGmKzYFaHJC6GG703muq/eAA7/Ei/eUaJa2hw
hMRAvfV+dG2cDb/aJLXduxaRz3krEKyYwtr11bHS02AMFyKJxSdCjtXJ2+C+tqPGOeVxo49Qenq4
M1ODp/hqmAZSw3WEKcodeo6OOPIHi43CR2R0V8hHUoMtCAgXnW8Cor0fkVZ/Fk6e4Iio1wozezkQ
UCs1zWEBLlMPnVjM3nqabek9IRQYV3zfvPXXmtDbfqUaOdw38zwbB3I8bef2mRPsYMOCllOxi0VN
2k1pvy0DhfWjKYsJOX0kSuKDO4OPe+ntOmjumG9UfcqybCRlLhrE/wxpug8wNWJjYwsl3pSGR86/
xgMOAtKkiXT/lvzt3MFNt/Ffgk3iI8bRV9uqnsVrQmojw2hynCdTNdOVAPcy2qYh4dBy582CVQ+I
4v1LMlNZQtnLxE4GhecNACH9Lh2r8idEDuPOaNrxqLuttTNmp59WCEVFMhx7++vHr/Z5ZkWTGzsm
apdceJTGL+DPdDkFBB/xbE5WZYZWTRfM6Kr0VauKbNvoGanUjFPfiFHKgHpjI7prLanzwGH5CbSA
SZgXnUHI1u/Xwc18LYr9uHrunMaM14GlAtQFJdaUgZepm6RrmgdaVOLt45kvlYk/H3KGtVGRpeEL
qYW6+VkAmAw1wl6NWT/78H6i+6gs6Yvwqdovs5XEuzruq3gtSiLyWwubmS8fj34RC8K2AH9Fwd4F
239BPBQVMFWs04pnOMMy2uqZOb5pRcdPyBse4iOWq+aVJPqyeuwgpkgUzmcmiyfJe7/QmM+h+8Wt
8dRaaRUWDv42mSfjW9lKYgVMIuu7AQt1fz21RftaV3CWqfFP4N9sKtz/GgwTLi4a6iR4RODwEd//
GGTcKJOa5fjkD+iDTpmhVmgvKDtEksV7DJR2jQn/lzCRxidJLQApoBTniGSw3d5cdNb05NQFLG2Z
OHth5cPnSVXRNfmA87GWvbVYc3Cwgb/R830/OQKfqK+RXnymCIQdiCgr7xF9sP7gtj0WNf+2lfDr
o8QF3hNaNPLw1lmQ7815ZrlwlZ7NQekjJk5BEkJ5Hf0NfTTz1Y7rJLky5EU7jVY+aTlmgdBmkd0/
r4ECjRwqcMvyBclej5cRJU60WwVs+YyIRYp4j9jjYHyu9JEwllB3DtYAZqzXKjZpfTZ+bEwrdMG8
eUOerfdhPGZ+tgUga944VuTy9lix1q4SgY4bGXYfbNH5wnOlsjB7/qlr8fhlAlL5rUAizn3+eEEv
LyQmhxoOidMCFj4nIQAwGaYMZupLNwaYIYJVvGkInV9yNU4rbWzdE3BG7cp1dE6LggRMRvGb4U61
ByTocl/9kZaLLvbr2S+rF/zGkYESDTpeq85L41PsdJ5zSHDvXuPyKaBzT43jHX2jxvKp1Rprh9p2
X0MZ7qZ6Rzo77oOJAGBvTpq6hh9d0rj31+aii8qZJfBDvfC8WJ86AGJy2ZrPU1PWqCRTK1E7C1LX
lfvh8ggxTsCykoNTajyXwTVUFVNvtsznXrbZtC1n76cD4ixdGb1Ok+PjL/63SXEvMB+yOw7v+XkV
eW23aMg9a6WGY1Uel8nBwytrunIF/21Sf45zljyCO8+KQcc8gjBZ+vBLwCGEiJlM0ZquD0Cyj6f1
t+HQtdYtIIXQac6bc1g2efXoz9ZzSvebZLxOT46TFj/0JC+v1UYvl5DCN3Dw5VVlyHP4QZqVyktS
kyA8yodvg1ZHbthT1fz0r1Oiqr8wZ5bzCYHgLFiQUjebjB7ySzxKAz/UTs28IPTaVmnWmK8fD3YR
IiyqKYs0D41dndf67GZ1UQ41fNwXX6wq75p1IsrglZwINXK/s6cbUGLpi5Nm9a8ZBtVw5QBc3ELL
4AAQofzS9eXpen8fABaw5pxU/YWEAr/AANqzBR/PD8Isiotop+q8PBiROx/+fdLIERABA4Zb2Knv
x4XEAoMQQuhLopqIVg4OSJvS6+KXGcPolypfMt6h0900tB3p/vNjBoCBCgOIMUT9wNyeje7hcKdZ
tYQClVEstYYcwtlYat/tVtaHLmmv1eQujsgyHqE1mxZwL6JE72cLtjNKBLDCF2SVfe2YDIaot2MX
FaBnENEI1h8v7sUpQXFsgV4tMlO4apyrgJkuynlEIfh/NrESFBWE/TOY62uuOBfK0jTjF7TdEmPB
abTOoyvbTgreWTG9+CmVg/+wQLeQw5V+jMdd03e3bkGRaW92bhBtLBpX1FgHV0q5K51gOhZe6hRh
4Q7tvI9SR6GW6tSIpuC32w4JCeHUzEfpyqJ58f2k3le63hj4/WidWOX9jMMqOg4kvKEqSXbVDho9
hH+s6VwMuJvse5K2SCl8vLIXHxKNMF4Mj+B2AUmc90oa4nRPIRDwMruaBxpj9L4auE7upNtdE+64
HAr2PeVU/Ong4SPh/X7PDLMZw55LmhdUtdVLkuSBuRrS9glfP6fbfjyty0jrtzg9TCJcT0gTfos+
/BEWgLdNSR3N5qVb+GO7aGyLvTfYgbVCFUU1vwJdZe2Cb5mdXWJ19TOI/5m6+TxSBzCiViDIUM5z
Uq711tMeJ11Ic+XJdgQ00Mc2loN2PP/IYp9OBCaS5i+HaG1P72Cqt5paDDszLWnlvYQUI67gWS7u
18XqAuGchTBBmHwuAcIRb/LUFd2L4bU9gn8YpaBlX3cPo9lUXybTqzc25uK7jILsle1ynn/R4lk6
eER3NhXyiwjdCISMI6wYX+qEMhdagzWNc2xm7W7VpLpsdyKJ52vmCxdX+nIaaR5CROOAApR6v3E6
6fNIwjB+MaSB9K5GRxNMSp3htEC4NtyVGMtsizb/56eEcWkfooFANAAZ52zDNo0Tp6nV9C+mhTV7
yFfVj4k1H3z4Od96UkUskV3zWq384pgs0SGULdq1ukcEdxbs9MnYZAohpJeyo9yHdyMwjjDotUJs
o8Er6s3HJ+UivaVn6QEeQc2Ox4Nr/WyWYI1AtZVT8mkCq35KJa1oIxmyG4pgt2lT7Vw7Ne4XNdc7
aljOvmPKd7IZ2is766KugzkVE+ZnLGbePGFnv6MchWC759mnNm7njV2kpghxx7CxAY0asDr1nLQ3
Uy3rKMxqSAQhTCyuz95tgytLcrHf+CVEfaDTqC8RBp49piodairpY/bJ4r3OMRGIit2QLioY9dx8
DfrJ2hC+X7seL3p95KFcV2Av4BkTQZxnvy2U5j4dveIT6gD1/SIfn4W1LqxDM6BQHEaarSF9jS1s
HdpKurvGr71bH9hUsupqKTd8Q5qrH++Os81IQAFoAX8VF/j773z5/dHzpCMLfHkD5LD19scwimjT
oa+OoY836Q//OhZ2eLQ5FwIFI54n5CIuND/2huToRw6CzP3oIFGO+nWzVrUPCu3j0c5uMmYG35SA
jcXmdAOvfD+zRaPRRXg9OtRFYO+LYGof9GySa/yR/LVpivbfLDKW8XhqgVJTC/udsb4fz0SJz86D
2D04QRF87vUKJZxU4bHldLzv/zw3xgKLQB4ItMY5m5thwh6fu9k5lNL5nPrSeCDQaI+QW4dV4wz9
7uPhlvv3j9z2/1NjJXloiQQJ095PLVdxh24bhiM5GJY1Wkh2qDl6tbG63AgjXZv2qVAziK+g2EWB
JbYfD39+g/0en8eIhYXlQ2ns7LwKF006TRX+Adfg5Fviy+IUl6P+jQKI+Ob3mqJFGJj5ynJK/0bY
+rSLgMMexWzrV37K2cv8/19Cz5jaqLuIdJrvV8KxaIWP9FQPJerZa6ebpx9odnjbBr3Fe2p1OZgy
dJL3OWK1bx+vwuVJheuLeD0PZQBw61wzbqbP0BJ+ugcN7vkRpCJ+6NwHz14lr1GYl+95/r2JAtjQ
OooMnn92Uwu4R6RzDFWXdr0durRa80TjnDl0w86dYCd8PLWz+/j3qsLqY11BOvIyLFP/I5ZDXq5x
8slgOxuTbVGDzNqTj+Xsymj1Zt1MtHlXrGpzZdjLadLGxUOQesmChjtnGQEgQlYlGu2DlybJV7pP
InTnbtyOVquv0OM0riQ5l9NE+YFIHNoHsTgl4vfTDGZ6V1o8WIe+sHHiHlJzHdiJeoqiMnJCSfb6
oHUm/aKPV/dy4zAsJQg6GcwUpP/7YeMy0pf71uYi7NOdEUvn4LfEr3g0uo8fD/W3GYJN8imEUbsG
0PF+KBLyqO2VsA+TbPRfLS3IL1FGISvER3YeQ0qK8y1+oNV4ZWX/8iWR7+N+oo5Pteq8KIZa7KjT
13YPY0rMhlm3f0LCY1rVjaARGl0zQ/7LhUR9no8IQZ1OBW2a9/Mkz6q5EiPn4GKvtzfTOXvQ5gFT
pKJxp89mg+KtN3ryZKYdWu595KFHjR2hfdQBYF+5F6j+Mdr744pY4x+rfvZr6JmYuL606Hi61vAk
HNgmh7pxkYWB1TQE4dgEeRCCM2+cOzDDtf7qiaSFzmV56qCX/RghmZ86yBT05oDkB+gGt1mZM8hW
nAfIy8O2zMS0EY5qnrzSrL77tWN/i7MFLG3pk/7CCzu2KxMpYg1qdTzQ54ydqnvQLRGJzdxHQn4x
0UabbgahNf5DXyFwu/GSoHb29iTLZj3ZUWR+hTGQ9ivbZwsdZ7Pyiq3Vd3q17pt67j+DKzStZ94h
A8MVgZ1GqANPEmGZF9GnCrQZnqMljj+byjDiz2VlaPHaFGl3V1tlSdLHhO/61DXqB5Dl3kHLxpHO
a+oW3ibtbflcECF990zhPSs7mnHcswJtPzSx9cvEBOVVd/pWW0ETLCvQ8FpK8FYghRkqq+ZIA50A
plV3udygx5h2x7hrk4dhFqZ757sCnYYGfv29l+rxE/yY/FtpywbxFJYv9OwmOGaRo5KVhXNktUKo
0BefDKME2T3kg/0V/dKGiqhhzHITT5Gydn5X0tUWo/ajkXZhbgZNOsZ6thw1hPx33Qkhch8FUdEE
ISC6oj6l3hRERZjkVn/r9QFghQzFQPfWj+hDr6jBatFD7Same5tkmJ+EM3YJz51s4mgn+jy5bQYk
fUPdr4cfeexgaAvUpEMzJdZ+ZJ6BawvAsuJbXGToMNG5b6T+qBU1EstOIYrigYzT1l5zS87HVsR+
8DoEuci2Y2JKse57DeTqIOsxOGp1q99QeAQd0E6TBOWmxhGZHAcOyX3pYSsTCrMu7K3hVjyEjW5U
OycB0XYPvx+YYS97IO5gjeJ8N6BePK5SP071H7XRZ/UtBxqhY0nLyP3VBmmcrJy5z7r7Sihr3sSW
cH6hxYrinSdQ2/JapHGtEM6I4dxHzggIz3fnKt96aISt0WuJus960YyTsbKVZd8obKPaLqRsL4dx
bU+j9iZkMD/a2CzN32lXVFO5EVEnXmtLz9Q3c4q07/WgOD0Sgg6Y6DqaqgLTHTWjaoOPLwXquGq6
StHiSfT4WSaWV65zbeqLkzeVFc7RuatPOZdrmusrBUqkDSlk59ozpxGcaGFW/XGANYNwe9I23o9c
mZpH46D3mi3+UGoKQt7Z5EueaVTdcxCAS59MOT90jNTlvlADqmMVRd6wgRn3rNx+tvYjWqwPID8N
7+i2Wi1XVToVb41MpU0zppbaBo9X2fPb2kJ9QexwUEccmcXey1WCVNjkVP4prqpB7svZgFrPuzXU
YY3o9XQqMLVof1JsS9ufvWbX9UOS1/R5Vngu9PXeV07lrGzRNYcSLwmKcxOdqRAVVBT4tWDQkU1T
mlPfUHSwi/t8GAvI2pY1/URONxjXZJ6WizDllGrwA9Bb3bCyZvtA69X212joGV+aZigfUkdz/W3c
+CNeF2blpJjQ5RkHo52759LF4hVRzCpowqRuu/i2XayYkAdSiCoa4OpNGtdUUQCg6KRxMXzf0O2r
NDhkaBh8KlFxdcPBi/kDgTW0Yee5Mfiviq2yRcm7ODY2ln4wJ1zzJLTFfkGUqgCQQ2cr3xRRN2br
SUn9cyBmrVkPmCuhRJaOHRVKLxUH32rwpVQ4p1HAmWeUobGgNO2dxKLAvpEydv8rxejfIxhD67W1
uw68S2H32cbrWYfXZsjGmOZIF/ersa9GFGARrUTK3R0jK2wolcXb2mm6GBPLJh1WMWAinPaoLLxp
tJp/DUUcvI5AAl/cxpLOaklCK5BFwfiz7zJuHwsFzFOm4uQJuwak5Ptg4OIokiT4rGm9VRzMRM/k
DpWn+ZCxTWnkRVX0ZYwLCcDa79L/xtzTbz0Ju2WtzXV3m5i5H6+Seer6jd9p4yEI2uproYFsDofJ
rD1A25qCeBdYvxrNbBHtdFsS60jU1Le60Ut/4nJSUqatvCpYzDsLLiHE6bUEnQN73s4Ao4IdRssI
p6im14wVPBU+0tyq/D5JMOdcERRNjyb2NAn4LKcr7oMkHz+DPSweszRK560WuLK6tzOp2Y+WrdGR
DIlto/YwIrD+S002zleNlcv8sRhn5zSpAU9bTZvK/+pIjd/0RDr5Ft52YG6RqW1ukqVTiNevsu/a
KXeNcOhcuWgxUN3aSWN2b7wSxHDogaF5KSgwvyHTZ8jDOHsDslqy5avYSOGTHRt+seoQkxArC8+Z
YiurWOvDSNUloKkISfG91bO4YY5O9S0yW7bNg2OL294Z3E9DVOtwV6UTHOm6x87abe1MHJpIDu3B
IklTG4wbO33TVIGGx1XWAQksslbeWGlfoCjgpkm7TiuMGVdOSws0dFPlDLcOFi/3A7m3XGd62erU
a8UCVLPc9KYI4mDc+lXpWjc2RMefWROBHkyQF8daYBAqC9HBaJ98YXsgT/20yDaj1ndvnY82obJQ
A9tQFlZ7kk+dXhLK/G4YJU7+KNKo7kCv60UfGlreQZwI+Fg7uBTdE+gzXLoQuTLup6r2iLNwPv4W
5KY335eF7YP8zPDeCw3SizIcW0IYXpyyQgcW/yMttHNDeVxDgfHDs9NyQIN/ULdK85vvWqwP+Y2l
D+2bIaAQhnOFMcCzLgpIUH1T+l8sp5XtyhhE/5ZpxpgfOswQy71p1FF84k9YwarW2sQLWzPp7v0R
JsbJT9rhp9fHkDATVzrqs1GpvN7EbaNT1y2EZewhxi62V/OEAGZqG8rcpbOvnpyky1ImSPq2bq3I
97E6jJrokAOXvZu6GkB60uRGFiqg5NYbUhUq3fmzGeVrWbv9Jqha4DQV+MW3nvdEbSt/RPB8iEeQ
lU4+uChvxl78NbBbUHf0TsxszX7ug5UTu7YfmnALk8NYiSnbabo/eWHT6TI9dcZU2lRnrajcF/mQ
bMDDO9Gu8Frrc5rIudooN28wW+om4rIgmKdnFKBHuUtHwsgNtq0ulSHiNATmtNHx9iII8ict1QZr
G4NA9Ff17PkPWWwAyCjB3N/WgVXFx9aQwJatybDzfZfH/lsSlJDwkPjv3a0Yy6xaiSSJJO8rwt3r
vO746kGVlOpIYRBanANtJPkigeI0EDE76EgloMK1OxHgAf3HJXxfoEVB1F67hriNkIaOdtREsQpM
qyjNDjmaGxzEAXIJDkwSFedySkGjmVjbVU+u7RjDMWHTAxwuZfTizYnWhKYWGx1a1EH1E8+lHGaK
QyjoeLw2x8FEFbobCg5Ankco5xVQSXDUpFsHb1fvik0bxBA3WtC6MwDjmZCukOi+hzYW1LLZeh2b
fu2mY68vmzoTtA3ieFPafqJDcq884wFyVN5CdhPwXvVAYSE6OUl+ysd59Nfj3Ob3bmVWzUkIU61b
rEcFXjqV4vy29TyqF0d1Qbump8Yv8GZHfCoFzpsvem1Ewwo2m+IAmPAet0OjVdg0W21iHEjCOyMP
x6pW470JZSg/mM4kgrCtkFXgAk/qbaz6ZohDsO1gSxYZSKJsz0TWHu2aqP1S+c3YUJDw+3ht9EVW
bXHs8IJNKzvtMadyb/3nJ/yfwxoGVLSCFepq6xoxPe1B1bZBaMDNVa/9pmZY2ZmiukUVtyVMEYX2
JKt5ePGboAB/IDuVoyeLRKPWKO5vn+AU5ShNldUNjSszP9h2DwLdCCq+XGUMU3eH4qMXrEAY1MOt
3QrCGeqBmfZAZE3o5cSy9J5xnNG+LZXw6L95kM2dQsde7bRWkiP/e/JP44pyEVVedBHP6gxOTsmk
U7F9AK97nHtQXiYA1VXUafZWF9OvhYV7pTD5u3ZxnvriFBBQxUYcFVLH+0R8QGNF4lloHWh/eNmN
BdHTWgsCeBSqs3FIFy9f/HuNpJHmMUq4hsJ66M197miNucVNC4Fel5jkE4CTONnEXOFeSNk1/Unz
mK/gGnFyozdgLddogrgvdtDZ5Q3K+MYP6mDl1pySKbn1nJyPp2irauuu71C/ajWSzafay1LzZI6D
GFFvQCR9M9lFz2K0ebYq9Kq894eeSzHUsNob/8tr6AVhNfv2Lzo5kX0wROJ/0hHdm24qOTpfXIUO
SFjyhPyC5kYSGLiRlm6VPWsF2ZcPjoUzKnFrTxsfIeF8ULisVAX0LIUok7+THWfhmHrYBh7QitLV
lirOfJrcwSy3BqaKxiaZ3PzTFPhd8qnWokmsSQmRTLQ7yNq8Diq60hS4rKgCmgJzuTBEgcg4Z7Vd
ogYzUCU4LnwX+31Tdyagcly8wKYCiBNcCv+1nfmaJVHkXaka/W1otBh0BIQR1QLn/H7zGHVcgTfT
3YMVL88+0e2Wl6TZBlS7iWSisvvqUeU5ebnWbz8+K3+rIFHMRVoXuxhAitZZzcaywRwIb3IPFLZR
aiul5YXsnGhhv2vdirQZu9uB7NsIDYUYc4g+IPqpikv1DoHcYrxyeP9SQUOIkL8XnUBaQktl748S
rGV5dR+jW3KY5r7d1UMZyLU2avqxG4s6pdCSjdeIUX9Z/kX7EOEl4K6UJ8+6vm2AsHteDc4B7Whz
jQhAvBscVGWB+CdH05jGXdvgNWTNtnj6ePX/UqYEkwWUECgRRvK/P84fk22NEQ17VAgPgVL+toji
7HtRA7ackkA7dPh/Lm4Ks/j37UbXl7bvUjmkZrisxx+jWqaI4qW8guMFLP7vRRFYybY34RANpjdU
a7LteGXDskG2dpqDa+3Hvy330j/gLwOl1/PhJ22clYeH9yHI4WKV6H6d/HEaHuSgvHLVJk30I06r
dl8S5Ikr9/RlhRKJIkAFADLAi4FDeT/1EhZWQf7rHvKORDTMJDXVFXkcHqZBO5RZmIEkX40mAbWb
9u4tAsTFP1fBOclgvGk7QlSmBf3+J1RdbwVt4jsH5PFMkKIyPgBVucm9cr6C3rg824vQELr4Ni7D
OrDJs0ep9QZUCmfulY6SX7+1SgRvuUB96ioisQt504sCEmCDc5e3DWSeyceAUmyyBbHs3wy90V9r
sFy4y+FTGOCxCKtzwXRQs34/excXeWOOM/+Q1NLZmQ0xXmgTFO7cIphPOF03GU7G4/zgFVIVp05H
0f5kl6DcTwJJhTXCxyS0uZE2G020QLf/8UDy8ziLmGYB/kCO6uxo4AUlI/yVg4MLe/tWmtRHV6UW
ODdKTMaNhvDGqvHddP/xqBd33jIqJeOFQI/E3nm3ggKfaEXX+4iv2d5D7Cl8FExE2b7bNh4Tocht
/8qIF60YwiKiIwIWKkwkRGcvzhj7fuSPpnPIvMnEQr0UyT6d9ChMuH+qK4Mti/YuNkLPDiovJ527
jrHODh1NpXbwais5akFpPw2tNd/kYgFdDHMx0qeNvR9g/JtdMnYvHy/s5TThgAIb5pMCrwUp+n63
xdTM8SytsmOg3KPviegNl5wFqT6k11RHLq5y2vtcZwQOvKSg/M9alYHf8gv8LjsWdU+h180gi5Nk
rI3YM99mu9r0iKs1V7brX1Z2aRvCUAL8CuL27DPOrd3S2MjzoyMMLQkbNzbvGi+XpySOi/nQFqnR
UZyZsmQf61D//vUhWfAjLoxizjOM/HOLO0eXJs0mG1+uARKrKgG8hy2NN+pWhSH3GSRJtIuhWkCd
c/vnj7/t5dxhq/+O8tE2AXF8drlxZwzmTCf6EMUNHjdmjbqTiXrbKm7j4QirsTo0rhrkSuqd/uvj
sS/MYgmXUMxDEY6QHrjW+TtikW9NtZjSgz6V0ycc15typxtqJKXLaFcDwgzqm7GUoEvaRKjo82Di
obKuu15YVChw117bqurLeDXjAFl8N/yxNk/YU8X6LheNtXe7fPz68Y++vGWIMxasF+d+4fScXb11
OWgUFe2aXiGUXKofXyfcXbam0/zsx8C+Zi55efYYzmF9SIv45xztZfQj7Vnp1ociRk/fpmL7S6HK
sVWl0Wbhx1O7PHyMRYtq0cZYlErPpqZXeOuNFQDk2AbmmXcgzeA9Wi4Gk8aYppu+aeO7MhLDlTbz
5QvLioIj4uIG3EqscHa1LfoQvKm9cWgC0Y9HyrXmRlllf5sStH+TCflwg7Y/jOegEMDJKq19a6qe
SjbYhvhfgT9wFBEpR4GFdgKic2erUE8aFRwlrYOBsM4X6KzDvW3FVnAQgd2XV+iYF0sOYI3onNIi
ahEBe+r91YoHyOCUFVAcqmbgM7FKb4x9ysbzD5oJZAFXkAa2+ASHtLgihnyxkX1uWUSmkRMAycYv
eD/0Iv6blmTPh9kdCzM0OTu3VknTqzL7exeo2seb62IjL8MBWTBwWeYFO8+QYgyHR4p1/aGBxb2u
1ZQ9QLvMduNQXIvMLxcVAWFwNQsWjsbiuUmGY0NaT+eyP5ipnu2EbUabDIm0lUCwKMH8x7wTRqz+
+UsuuEzigWU9odYuP+qPdAAoiKeAUfeHoCsHf52UbtGv+gIKV0hH1C728SzlWybFWBw+XtmLKxyM
PbcngowL7pWo+P3INWUgD8nH+QCELPpiz7H5SB3YdDZW1OvtcUo9LOBw/kJmBAUrxBo+Hv5ytX/j
uIgOEPdFFHH5eX9MvBOi0chr7QMejwGMed1LwsIuqqMacnOTt+JNGmjifTzo5W4C5bjo2JB3OSQA
Z+cmHXMtm3hLD1Va58fCcHprhZ+e16w0ClfR/uPRLo4Kvu0ATFEMX2hyF5zKIUjoNBhec6plPQgk
GGpaY3Gc0Jh0y+GNkjEr/M9DQldeEHrgfQHZnm2ntMRJyi8GdQKiZ9BCHQqaekVGgAAaf4yPdSzV
lVkua/YuwAwoQ6ELBKNikTg5TypwQCkjNlJ30jFtN3aJQrz3UCs6kW8fz+3CL5UqFIApLjw4MAx4
HuU1YArcLIPGj45QVR9SrXXLVUpNOP0Zt6P77DvtOAWrmYofihyQgb7p7F9xS6Mme6D9O6Q/qtIb
3BAnc+8aivzyY3vL3U9eTzXDA/X0fj8j5oC6XNzpp1pQ9QxNGMyhCUDh0cd4bS/a6V8rZjADyJIW
pX8D1M+52hbWi8j6jgFd4WIcvWPrzfYdXnG/RsNIdnHkGt1jJi19n/VDtvv4Q1ycosBbCmYLCvQ3
OWH5938cXWDjjhLYqp2wzezdLhSWhVeGM0auuME1LbkSZ19usGWqwGm9RRkIHdf3w83KwgkvKquT
5VfN/0g7s924kSwNPxEB7sttksyUUpJlW1LK9g3hrYL7FlyCfPr56JuxUoISnmlUA93lQkWSjDhx
ln+xT5rX6OW+KiHdXNjJW8h5uZPpyVhYMjHEg3l+LnIAtYuBr6u1NyUZTbbECNZNmzr2WDxXzuKr
a43CrUedWqumn25iN1/ff6/n62N+scksQN2jIAW3vG2xv97rlAm95ypMb1AErr5ahWnjGOkgZG9u
EhxJ3+Tf4eKvB1ubShG9v/Z5OP6z9taX4v7bKJFnFVShOk0mJms33K67rEf6ktkKo0qvXb8Mc1Wf
VNqr5/cXPT8z26LsYNoRwIkpI856fxz23F/KPrvJEo79LgMs9dmeOwynBoVpaM7gXlwIkOf8A+7Z
jeWPCSzUCy7ec5FYII+mEYg1v8GeNY3R7UmukaQePlpeNkSucssrVPzbcMST2gj7ASScBw/swtt+
40tvXShg8FhubvSDl186BzDTScZgN2gpWM8BA8B7DcnkG3+yQb45Sa6OgafNkYOkyoXT9Odi/XuX
by+AQgQwKMkOVJuze18CDTKQV8tvUsaUODIwWoYWL5iS7WpMhJ76EqAYQ70eg9+1XddrWJZaEhZC
YyI/zBO+XL257McF2BZ4fStCV8m9agFs3zCjyL9PMr0oHP6nCX/2o1Gi4FCwNclWzmvtsabgdPt6
PfZzkH9wFYK+kTYDXd2h/Ye8UTbUSE1jqZiH4GVK9THPhfhPjtZmy5AXiO/2XCiPtdnJ3+DF5idL
ZaK80nLT1Xamy2VxGwCHzL7CwinVPgmaLLmtLLHEcmKKfQuQpxKntLPT3yrTiyD2anc+Id89Tftk
MfurhTkxqO9WaP+lbaIMZCOsJF0YAeVtd09/ZryFQdmv9Y6+b51HUo6jfFwY/hd71XUtIqUIL+jm
AWqBbfAldKf6XjWdERNVtfRbt3aL/NCYwdixK8HYhBjeWh9HhR7LUzM4Qu60xRjFEFeWdPQr26qb
3ynkl3sjXcdvtTLcGsM0c3oSzLWQMFoz9d8wG60GVLQvuuvCtagUA0LetLPtIbvRusSx47H05n2T
OPQoV8ye9qaV+skxCHrcWFVpYE8BYmcqHxvQNPl9bwz6fGUhVfIBXtGGd/BGlCRmZx0QDG4YIYVo
XXlanPVdUd31ZZFc26gkql2Qu934aXE7ZYRGw6icbBCcHWphUoqo83CvR7qbfkCU6dX8NA9JVd9D
WRJN2NSrwJnen1AegHSbhM44Mk4IsnW4LlrZDLulQfhowDt22iFy5H+DsIt5rWl2qohyRqljJDDB
/YpkqK3v8nlAGcvxUvVjRK593GVg0n77M2opH6bC6jXseE3zczAuPWUtxqDLXUucgEE+dZUXFqsC
AFMtg3Xj4hSLRrDu9zLOmC59g08qP83pWmwmyd4iD6vIPGg9TZOiWDRawd6bkQk8GInNFgF6v6C2
5MtiD64AGTNEdE0zxPHZ1/edtfbV1Vx1uojJbDCkM+pu+DUtovup662TxxPD/vKj7SVtcbv6iW0c
tMnpjLsg6Sz6MqPrn9bRWdvrYAJD43jOPH7K1tIybuk/lz89lY76DokMZm6HfGole42C8MEXeF3+
Hjsl2pt2CAbAhqNVfQM34ov/gFOkxSdnrjz1n8MIsYhrGI4J4mK4JF9Zomvxph6LGuQD3anDTOVB
laqs5eNo5VUW21YnhuslUAKxKbECP604A22EYK+UUZIoHONkQ5S8VvbEgAY4g2585uBq1kOiSnAh
3pQi419as/2TOe9cRmLaoFRFVtvmbh3LYXgCYWU++ylh76Oc8yGWTakbj1k6AmJLDJSVowV4s/sl
X5KZUhrbKDfAC2K1fxkuLwk/ZFvvQ69Yq0+bWuBTVYq0iMZUd55oxaniCYFjvXyqbU/JXUnPXF43
IkMgdBJa2WvoYjezAWMGkN0UFfMa1N8J1/I7bdL1W23k+i8dC4QMa3EwPd8GWSAQrPfSP6BcHBhR
YSXddEiMORnBPGA8GykHaDekhYl/0A4G0R8NSS9mh8Cf/hl58a09qAbndtYrvNNwGEPcH9eapL7p
emWtoT0JHIRXaRlh7ulwkeGkjvdKdgxFOr1fq68aMzgQppgmcj6cqRtCzkPf3tJCTsZY7/DxCnXl
0nszhzQ9Yt3HbWJxMXyHldyKHV18d9ghFRbcGKOt+nhtZs/ZJ3XrNOCZ50LFTb4mX2S2zH1IY1M2
DDyD5ssE0bYLkdPtvyxBy6FNqGefrUwEX/MRWcM7z8Q5W08R5DtqfZIcgsbW9HAScqyu6Bgh07Qr
aeIe29XMigPQVbKbqsXCRoU5fghgSdGA/2yk9WIfGwxW02sTqeDrzlnH5lPLbLw1d4jQpUYERjO7
C+xiXI4jF/tRY05jRMh21m68ge1PQQnQMyJVQxUskcasEZEb62taodZ0aANg1gcqttyLfFAvepiq
zdTENST6TrsFsAiy18FUNw9BxfX2bGelWX9sR+nJI1Zw4I/y1mwrmMZLr101aSt+J9IxIDMTtyc7
HirDVhEyq+CaFzCW+HIy4Pe/BMIMnjHCzdZQX6rKw5cdiY8IfK+LT70AmX8NTt6fr7LUxssK/PcA
MCsf6f3cL8OQNB9k7k7zDa2vFXB2xWwDnFeT1XL4Outpm13PgSlvSz8oittq6tWxQjRV/zwFyj5S
LyHPh9mZNkaLO7QG2fTUXVsGkvQR9b1ZXbfTNOThjBtqEDnULQ8Kl7YnG61G+6pvFi99TkhJ548b
Su0rAaT5MVipdrdC2S2P6QL3+4tDl2OOU+T/dNwFtMqIfNTmikdgYUZ3HH2U7jr87rJYzx1hfKd0
0JAxNbvmdmPFXMPLx9yzKt0GGTxXtqYDuAi2rIT9mK3tQY3t2nKSlV0Mtyvadd6Hdajn/vfopt7v
tGyaZk8XzB6udMTgfiGBC9AYORGXIUti54AIDKADTbQBNEBLUVkcVqfq+x90Suc2cv3S/h00/JQw
WBDS2wM+N+xIucIxfrapa9S3wYqwM4B+0N7lM0J9bX6NZaWR/peMiWkjDZnUz6qE9nYlMqQTQr+s
pitULW3/2tIy51Qa9CbHuFp0egJ0gNMbz1mUE/d1r1lXi+Z1NhR92yxvnF7M3zMvm4YodzRdu0k7
xBBu7NErRYi9l+3dJpOvHxDaoAhraqSGn3SlB4eFgSCqWTomSnv0SZr6hyBOiLBuOgzKPA8liVAB
VnEPJfepsd8+p4vGURJkOzkg49/Y4O8gcdD1+kCEElmkC9HE6YSnw/VmzFQgIp1K1BZaQ9NbmPB+
ddKsHLhnq412sq9qiwu/6xBmA65jzpGZ1WZ68FY0B/fkiBNIRzQL891koF94Vy+AsENtFv0YG6IU
Y+QOg/OsgnkRYcuPbBAG7bw8npug/NEt3UY+DyYQkUNWenvfTifSGL9JyNCCDjiwpQVPplg8+cPL
m0wryKn18T+v8cCgNUMOPXHSM/qHU2r6+V1vr4Y57Nxqze+Kui2d68Xzs6hMqsyJtVVZiFVatbvs
jNmTTli3rZXEpMALsDqvcG0grZqXfcP/uyTXTWd1X9BCxb2ha90xymp/8j/Qj5HpfeXVaC4uCB8e
KjzhSemYaAUHbZBeDSazEQuYvE76mN7u2qBAFGkHRNT7CFGoaO/6jI7JZzpI+Qnts7W+UkGPGikZ
htlFM4J4X7RmAjyPAmNZmeEE2KK9QsAVU7I+Kx0tho8GLaBzwL9NtaOmcEaoQe188GdtvSu7VJt/
mlkj5p3XNpYds7lBv/lmtdCYpJcdEnAq91tR2EUfY/swF0QqWnuRMj1EOroMq3sxaFKE3WzJu8xy
pfvBa+GgBTsdHHJ70+DOjYuABuA4TMnL8EvXcgMYd2kjmK3PflDfAWFvexqvidblYUNyXN3OSOTn
7NlSA54DhnvLuGnyf8JMY3RIHu1O8zYwMYIvuVtVC+jsXj6qvnaKyGgQ4Ykzz8V1xFL4trlrri0/
5xXdwAi+y3zd6UUPjA/pkeBOJOUK0d7iJjA/tsEsP626GItbeBtBD2dBBr2ooSghJHK7Vkb6zdWc
tL9OxmAhbtEZMT9r/lCgwmptuSdMVCliiYhNinKYX2reLmjQiGQWtKbWnht1RDI2ZyYSDbKsRVSL
uUQg3/HMuxT7uB8g/FuAGUPgpQetKKerzApUi8J3URS7AQCXfjuvs2aFkAiyPjJoTlX7KiNfC/FN
Sx5ZunLDoVvW5ph1vTsf2ESdAy8qV3qYyMAq7pdSrtrBkUZFx7BNu9BE+i34MI0Z6ZKdprVxqtYN
jFoudVoc06RHukAVo5QxyN32yhVlpseIeVHgGcCN8cEoQHVGTtPoYBQYBWlJtnO6oGuIZF1Qh5OW
exWpyFDMP3yNhGRXDr6jYhEEpR7BWnPanQMjbrkmHzGHq3UjVK8dJDh0/jQvAVrLLBFvqE2BcSsZ
8TDNYDQ4hVH4d3Ug7DXmLcNPTvEgnHZDu7qPlWuSfW4EF3Ejl0p20JhcSFPjoOATlZXKCFaNiOfS
X9NHe5LJPiDLF3U0zkF/8hJzyo+d3WSPRrZ4S1wucGOH3ZBDeAelMOZNrLIaNdOpH/vySk4df3/r
C/s3NJq0imSnhy8Aand00FJXBbD6KnOdr8m6ACBNzFXzY0CnZM74n7QK5eNhHdD65t4wwrQgRjS7
DPuT4lZlrifvNNds7nxTVeaVkNjacZLhdOKSjr7tvJtTpfPdqqUIp6lPvrg+wLGdC7EtQtfH4U2C
S+rCdla1dxRI23kxusbTt2W0B57BMpWMyUAS3j5IbveEWXgL8Nadp+LIle7HaLOvdYT8WfC7J4IU
CfgZd+h/DkWTf+3QrlWnqmzg+ukJ5MV6zqyfEEy65c6TwGQPs1GLb2h7TMtRx2xpwXKnKYZPMumH
Y2X3RhOlc2XNV5CjzL3RohoCDDntsmPVeAK/l6VY6/wwrUHqRAJDRC4yKxtB0dAN1PxH/Fum/jhT
f33vVmH812aoAO1KH4vKgzXybRUXWRUHytHXqB4trBh2rZV1XYrshYRfRH4OvtKUEAh3Ahz5J8NU
hb4HaVqux5oO87D31qZVEUWNM4egiJqnpepAo4LKcQPImV1BJNWd1X72cHpX8TIlRhsbINqNqLMy
MxwZyFfPyOmvwb7C/Nd9MAFFy6dOQ2wiylasiCKxOqm9X7zM93Z25qx+iA67sX5LpKvUBy7heYiI
3JVzPdGcpvJ1dLCJHVLeioCZeyZIrrUsjvbAz4eEQhQTocjpFR+KonYlQsiAxncrCKXU3mHbWdVo
awpjJkl01yGm0NGbHYmgPd+NRS8/QUCR+cF1a9M5bASG4+wCldkZZQUfyMlXozusBhqWoD4wXLkr
ODzf+4xAEVlBkvv7vJvyBXZClxVZnFhppT4Ebjd4Jy5aw3tC5J50fwcUrf9uJI7MP3aAjYxbX9Jz
DTG97tY7GFUGwPJlqfTY8rrgB5GVe6xuVNri7002udO7BQx4L6HbxOWoddle5UJ/lnCV9bAfU5DZ
CZbzwGiXWfx2RT7o1HGuNoidbWSJVl/oMr7u6VqOjXIscwKf/+FvXci/+sm9sRbsMb2/MZC7mu5z
1xAES7+ELABRsz30Hv2IzxU79x+NUGiygnJA5MQBbw3y7ZxT71q59POiKW+sRq/3yOkTiDQNcunO
y/LhIFH/no7oG7nWpfbuNgx42ShkgovqAZAAhnyBcdbdHBBdLoXJyqBCSOGotEuNvldrMhMXQofq
5VU/hCpghpioOOzc3nTDkSbLL2MS1YXh9SuEAsM/iyEggEswtYxxzyYl0lPObDtacVP5wC+47tf1
SMuwbOiCtO1TB/xquFmKnqEVlJJvuZfSEgC+Aj/PgN7xfrf9VdOZ4MFfZObkXI5x7hmiqaVMA3MQ
t9nklCezXPNraSC0QBQrYRUVLZKYgwdjAxH4+P2lXzX6LTBS4HuZTKIW6J+rCXcc0NEGhXL0cIz9
Yo59stdsC0qJbU03sDrzC03uV4/KxkcYEDwKTh5wwM6mGTh/ibW2luI4p10TpvPs3Dto3d+t/Ea2
wNaLmodnDmN66Yu/OnOsvOmxbG6DkIfPNVmUS2Hc20F5lAqofFwsfp9/spxxUVA7gTG06MoTuOEP
taGfqhobuIUMZ+/VqKYseg/xyF3GJYj7YqqD51xT+nooiE723rL6kgIygbV0aSry1q8Gq4pqJEAA
oDTbn/8VKdo1QRtKW8vjwl3pcjPPpvsZaqKvb91/T/6saPen1JUoc17CyZ7tDQbVcD6xp9iWR9Tk
fPKUJ4Ex64LT0FZ1Ouwg2o4R/K0R6ppE7GSXdqNHxgMnRkRtvfQdLdHchPtaNtqjr7r8V0cE+1nB
kal3Vgo6MDTLdDzIuZwvYF/OJ9D8Vm+TAUe7id6Q6Z6/Jy5XR65dujzw+buadAeZSAzFYC7uMO+S
844ZHopyQGMNTM+odLQQ48HyP3vSqi+AQORys7RNcxpzw/xXy5btt+HiCfyRoOMb9jZG/esbYo7L
fH4M1APJnLwBuh58NqWT6buubqtrhzd6Cfj1+suxIpJpwIqAzvKflyvWdiCnWhvVQ5klEJuKMU1u
AzJ3mPn0h7Jdq6zyknbj22v69oZ/AmZ17tA7FlNlTp5SDxndvc+e6y9fCohPz8ZS5BFoKfu/9yPX
WST588WByvG9GQu73Ggvn3Fznhr4jurBXh2o67VsgJeWy5PZelqHGrtGMpME8iNlzqWT8dbSzPC3
uRdKWUhJv1zaVchFkPwsD6iOy6vR15xNdMn52bS63BejY1/rk/Cfqtoent5/6O2h/rpE/zw05SHW
wEwbNuTK2cqVAfpfsjIXVvEJRn7XYwFE11ATpnUBAPXGWgydYWihc24DHjwLPaLtgqWyl/WhGA35
xVD+cLPJPI2RvSKje+FeeGP3sBi4URrqqP4YZwNnZlRTAZx2ecA9C7n+gQTPwHxzHIHO6iPiFkWH
Stj7L/PNNaFaBOCAPP67/flf53IeJi1QVFUPBI+f6EXNBH5pB9q+KXob7Z9BtsOFxO+td+qgbQXU
30Lqxz17pwY9EQvBXx4TDcyH1mzua1lYp3JZfrz/bGf3xrZRYEz970LbFv7r2SAtbmjXdXkgPG+k
9xwD4B5Mez9W3lOCO88VTETn5/uLvnqhYCDIacEDwmHZsGMvF3W6cvXLzFOPTp9RUgbpTJsgKQKn
22cN+BMQ9fAcL3xF+yyxJH/eIGNb6Dc2oM/5yF527WqUntc+gXW12t2wIj4eq6Ck/MnavPrYdKiz
XwszN6+6lKb+3l87Q7+uTXMMDiK1ZHdcjWfPbftnka7eR7ur5R669nrbzWbYDU5YehOMWDRp0jGs
lLvoh6WzCo0a1UF2m45ogD4Lvj7pg7ATdTUkoutDN5W1uxNtjoQJuBLroyVSmvkYbvanKUNAAvP0
Zf6SB6mV/KI8F+v3Olftr2Za/FtlTvDEsaRMJeRi0y8uvLRzwgl0eXJNVMO3IOIgV3wWwjzMTyyf
R9k6N4a7x1feeYYE7AXHDllvb0/1ME9Yv61YQeWafoPGu9aEIzTw9Igbh5sdA7+hxNOnbPhe0US/
dFLOM/Tts9Kv+kNHIsYD3Hq5mex28pIFoPRTT5oO5UrkUPDMYVHJweih4jHSdxhe5PQMfjBIo+Vc
OrOHfI5Di6hfakwl/213I31M28PdZNZtsNuvLEPbNpWenwxPRj0HNsCGBrfapNawWqF6KKJK9vOF
cPGnKPo73m9rAsPZqhVwOMBCXr4EQdO7m5tmepprY5x3GUXuGOboXtS0atbZjj2jmH4FWDn7YedL
/U4E86zQwZhs7IGNtenBCeGwWl14F+dxbPtdDphyjjmXEaC/l79LtTAbrGRun7xhqu7EOiZXgHrE
ul25lPP//OKhxwTc8wapqO+d7VXqcxdLUDohtpNaP5Jk9H/awppFxHhiRh/A8+fqwvk4D588HxC6
DYZDPYZKgfny+aQ1AA7wuvFJqxjD9kHdnYDC6Xspy/lnT8xubkrEYuYLLM8tKr/43IDbtmKU1d0/
5nAvl60QEGTWZWuPFhbB8mAOrndvjb78ang55KeKa4mAWnvNTb7mzaWP+qfofbk8GxvEIt0zIM/e
OZ6vT1AwoHPtPSKZxOjBUX6pvq65WJzI6V1veJIWdlp+NTtsuSZ58g1Lc66WJUXYyLSH4nslrCw4
zDb3wIFRqnzwlxwplsKUhoxXe8JZdlhmu44YdJg55hl97VJgj35/ZSed0uadPUA4VIcUkhCAZ4xg
Ub0xCmMeI9XSW0DLQA+e/GXDga9J3UOpEUYea/aUFoeiYScAsB+7MZ5FYiYHpkXacKdUGsz3dPSD
32jc+u3vOV8W+2HBxqP95KBmwLpTv6BKt9PRie/v3EQP/F//uInZv2CkXPCnAOtIcV5+2kwfvc5f
RfCIvARiEx6aMo+Yy1U3rZm1box1RnNJYfXVJsbMF9gv28lEPRnnk5dLMqxvUKSgEanqrANpkKf2
/bDUJfNG4YpNroepxGdDGE2yf/9h31yZs0pvgRaTec7cRuljpVc81U/cyzMnhY6gPpjjvVcbOmrR
CwYIZXIRQXi+Kq2cPxR1jq5lccGd3RhJmuuNhZ/a01i4vb0DKtJ+R/Kwb+JksdV35SzJQwd1XrsQ
pc+D4Z91YdNtmH26OOfEi7SfgGWoWpw0J2lBmjRIHPST/ymb0iZ+/8WegyQx+uIZN7g1VwKk/HPv
5GU2mKAbmvbUq1beDHJov08JBnBaZhpha3SZFVd+FTihxPU9v6Y2cK8Hx5PBhXz9PFJtv2PjhFsm
ZBduxLO9VdjMpjEyTp6WSfnW1YrF35dSVjVTwhmhGHuDuYS1GFfztsq4iP7xSuAmMHn+Px4+kHn/
SC7+ld6uhl+0HqTYk0p0PYcpgE7O1CTzc85QFtIyM6YLb/71A28rEha57OifnjfKhMnJ1tCKOqGX
NB7twmmjuZrnD1WJHsCut7j7dOEuDXw/Vx7e/+rbxv07Lm9PC7bQMOHzwdI+b51mgENQihiKUydK
/aDLWb9tyjFh1D3kDgikeYqH3HLuMe7rY7q+9YWP/XqD/2HA2KTYFIPAy18GkiJdEh9kY3ES0zLf
aEbjHRwg2XEx2tqlS+it98ze3oojciwEPF+uJT0GAYmRlSe1tvV+Sp3qq/TseafBmzpAKVu/0lTE
PX4oi0s16Ov4sQnNu5AAN0ouLJSXS4/drDFgDYqTv7rg2Psgf9DTsYs7cB/HVQbdc6IxaXj/257X
THxbGpPgRjzMbjZC4MtFlaoYSEjavohOwRMFm4PMbWagPxFmWV6oHeAh4xJw/40n3Qp7xr9oXJDD
nQH3NQNZpj5rqhNoNvc4jOvwyM5ayRXxNaDksdwvw6qJf99G6M8EvFi6Ndi0nsXnfAiSdbTW+gSG
4MgIS1jhTHclNucEgaj3X+sbR4b2DILMtNY2MYfzLbtyWOGUV6cmSaZvVaKC2LCRf8HJuL1Godq8
aelLfcW7yriDmnzpq769PHCaPzxkYPsvvyovX6Aw4/JVR1WpGzX2fr2DJIGAfDU23uduQUMgNRLm
YCkFa9ThhuFeiJFvfWTaGkg26xDJAJW//A1DphDKT4r6lMCSO/FPyKjwUBsdlI4YaJAvYqe0Rl7o
Gr9xfrGHcUkhXazY2WIvV22rLOjnNqtP6+KKKzdQuhsj5CwPTStdEapm6EK9DuCidJQv73/0t87S
1icHhQ7OhDzrbG1HywsOa33yFpBI4QyQFAyFVL8T1JrKuFmRsr2wp1+VqXRamGh4HF2aEBtX4uWa
6QR42sus/LnVzGWktdzDgczmIY0HB41j8HglEDlhaB/URKZwID11jh5qCTn4GT0vL1QQrxOE7fcg
nUJRhlAMPNuXv8d0UjxjhzR7XhJhAeJr5ik5IKpLZySwW7CGKVWGioOizbxYV0PeRj3mr2OY0Q3z
L3yQV8eAKIpi+JaomJRS5xIyi54l/mRagtZCPvxcmNXfpjPmuIcxV+jHDFLHsaQG4OOEo2vm+XXt
gXp4f1O8+RvoBuuUFNhsnH8ga8G1nHF09txLZ41m9s6V1mbl96KYvs/66j1lVoVoaJ2kayi6Ir0Q
31+dQl4Bkulc25wJZntn91kzt3PjIA74XOvCizkvXc7UM+mjaRiCrwbD6FtUx7ILKemrxgF0JWws
tpwBVVUGbmcBqMEZc5V5r52QrSuiBpd4PcxaiqTSDLKnylYeysDdskE9hlubYfrVsBSYWgp9vp/Z
mBd6yW99BAa/W6ueX8SN83JXKtJ9OCKeeLYU8im7tIYuoJZm1VFfyfWdVS3erUiK/qpZ/Cbi3K4X
dsGrsMT72GYT25iI6uu8tDWcjWDqrqjoupl4BJ8SnDbZjdvSs8snV7NdFI6yrvyp1mI+vb8BX0Ul
lsYz1eVY0jXzzvnn4FJxLHbYAYaSzRUKUZIv0dGq6bLl6Eytf3h/vTd2HMXeJmTCzJSR7vZ7/sqN
rTUzJrAL2TMZ1vww6uVA987UQzdz9Gh1EvtjKtgN7y/6xkOyt23AdTQU6Rxs7/+vRQu/QAR6NvPn
AJ3cezjNhJXOcFEDlzgra5d4R289I4ZEkN15t1wz25//tdxCaeDClyoYwwofOU5tDU1qehiPKdKU
rgDrapllcCG4OvxbX+ThcAC5y7cZMhZlr251rZ3hWyu/eK4t3Nb0OkUzZVx1WCEF3Yz3X+hbTxh4
WyLKbN4gQ3z5hPYoCang4U+ThxO4oln90BoL6tlr7oEmcwqKWj399P6ib5wS00QxgtkAPHt0qF4u
uqauZulTpZ20UQvanQjy4tmaay8SpTNFZOvWFNagGm+83PUunNA3blJyUXqcLjAIWr/nAz2kC3Qz
d9zkJBrs83YmZJIeRk9vpigjGwnYShcvwxK1csRlk3oIWyw9aXLCLN4VQzkf3n8Xrz42DWjsgKhv
+Qhbhv7yXaQkjksLov2EfrZ+7S4OeMZMTroflcMEUur91V6dn2019hUFyLavzxWWetMUhRz19ORr
WRAnU6UfuqQ4jjU6KOhXL8HD/2+9s7QlMTs1KAiBp1EU2e/VS2S687pprpDAdX9kpRjM/8MToiNH
JQnyg8zkbG/pVd6iSGOnp6xrvwtthHUzeMWjBIjFA9bZl39/wG2254B0onl+PmljKJznNPPykz7I
7DM4x+pYeaLfawlT85CE0M+v31/x9YahfDSYpWwWnzjAnmVemStmmlxtfnL1EZeGYDJA2+m0Pqa2
0i+9zVfhAR40hSOvE5aqoZ932Hz0mgw6mvnJz4l1GiD25FhP3tBGqq+WNfK9xLo2UmDE+/ef8vVG
ZeFtvEhPglBxLvthLGbhSNfJTqkCLxUubVBqkWZnhRGDNpdPEKhgrr2/5quwtD0s40T8vzkgAFFf
HkXA+YhuJmNxGoaheUoyaB+AYoPgg6cp/zFZy+VXYvUVGv9lWlwyV3qdUdPlYpBKGxNmDbnD2Xdt
hiyztcIqTiQ3ybeq91GfrlJLHLQqcX6gkZghG9EpE6JySu0uF6li4PHdP8cjfobL4G5L7MFLnCWS
CR6RFZyj/MTYZ53iPncKEevFvDAC07zH99/4q3xte2by1S2DREHrfHtBI15k0GoFPA4dud6gVvJH
vzDq87kv91lAy2AHGK39VtcCNDd8hOL0/i94Y59RO/9J2DehsvMGY5Wlq1+s9Jzg2I/mp3Zt00Mh
GLyEmAmIvb6WpfGvSerWzuQKYjDOuXo11DIYGSjNcorT2o29jDoRMPJ0/bZ50KBeXUEWDX5CIxnG
Qz5aYuA2SNILOKY3jjXDbHqJQIWQhztPU0uMGDQHN4ETAERf27WGV95NvTb91GkrBzGt/tl/hj3Z
XDjVNifoRWbDo/vEZO5eIHKvNDIgMpLA9Ul5quw8l3FeT+ZyBTKwuvBV33g+BppUJrQjUBY431fu
CHa8qkR9CjJpfXEGH44b7OtQwop55HWIewW39sLN87oYwtSPfUz5hwMNraezy64zFJ43SV6dMMxV
4nuR2G15QE51pAGlWeKBVLK3I51rffyhjzbKAgbKZT2c02m8RpR8WGOtm/NLRdEbFwZSMAA1mDZS
G51nWyhqGwK9q+pkWF2axi28mR2TdH+6QTG7Vxcy9DdWQ+kP+WdeP/D/85FmYwN1GFu+KFytsfsE
pBqlT3qeXvHLgauWXYjZby1H8U8mA84Znt9ZzGbi1Dd6D6IO8tYET9qixgrpd8n/NBy4vr4fLN7Y
vrw/9i44HuQMznUbDTliuOJ2DRQDx1oPaYL5zjHJ6+Lp/XXefChrswhD74As7WwjIUrQ5ISG5rS0
RfvVCCDwoOTODLoxpgsR+I07D5kA+jf4LiPpdb45UF1FnQZhhZPrryOeS0Y33UB+Mq7KFT+kWrrG
I6LQ+b5crfGCYNoboZd7BklhClfmO+fzrBr4tZVaS33Suwr9f9vt2f9F4h0kVM2HccgvmVm/ERWI
dtsuIftl9H2WaqsFcKhVes3J04X5GY/GMpJUYShslcVdmrSdiJlHAeV8/2u+9ZxAakFyUN4Tkbav
/VcRaQzdkC1W157QCuhCTAWyuLWKJrIWCfwcw7DDP67H9wRlbTJeAIHM/3m5XrnAy+mW0jjZDF5v
0NOXQEds5towWKFcSjiQl+aFrzYsq2xnnRYUTRvmhi+XBCdMmx3ThpNAXXaflou8L9IB8f5KSXxc
33++15kSA0GGNqAikXNH/O6sy1NaQ+NRVZqn3Fjkg1d380d/hqG1ryoAPojhtU53NRkGPNBSK/GQ
6rxrZvGXBJ9ebadtLkkooANG/kDq9vKhLcaOCAEY1gk/MP0KYqV6xikIOL0/1VjrOQf8vfJLZoWv
EMjkSnR5IBQwDt1ksM4evi7nZhGFbZ6wXiqf83T6H87ObLdtpGvXV0SA83BKSrIleYgT23JyQqTT
ac7zzKv/n/LGBiJKEJEP6KMk6FIVq1atWusdkMJD/fRLNzUqnKFxrP6RRw0TN7mdT3lZx5sxsHD3
wvwP1+sKFv5Uh+Pv25/kYovzoyjK0KJFtpdKyeJHFUnSyHJnaO9Snkb/9E2U+hhBDI4Ks9YPsvs6
qoFW3B7zcs8xJmpuKCUhgYVmz/nytzzW42I0tfcyt62fMY52TxU6AjCjQnV7e6iLuC+mR0WNoi3e
iWicnQ8FBW8WF6j+3o+D3noIieTpph6kNV2taztK1G4JiSSH+rKaGtidrFdTYOAllpYPtPX1H0GP
wUYTKM2/Bk4Zqdtp2toVcO3jIaIJ0ghAAw65i4U0pWksEn7Re9vJiel2Rg+rLmpQHKG/bn2MnYNo
ze0FvfbthEYa2Rmx/wKGW7cVbYyg1t5xQNYfpMDSq7t0GFF+KHp7TWHx8uvRMWFiZAkEJ0Y7/3oF
jrFSlsTaex1pqvRkoQGhbdu6kc1ft2d1cZfyagKcwRekVYNc5eIUwLkEjjIbWPFqMtK7eive407i
y19DYtkut1F93wwaBtOIs1rpyia93DyMTlzEyEBkQkt3XKqGZR52pvFeRgqa+VKJkNVQVfeo49Sb
AHKh5DrmVO1uz/ly85yPqp4vbppUUZqqEqPKU/8tRMtkX8D0gZehGv/FMIBXLrdra0wWS7glTXdQ
nzsfr4a/P2D4Z76jY59uU1sNt5QSI7cyg+YRyY3Ki32kiHFN6f6HmTJXigNokXLZiW32xzUe9wEW
NN1svqPMhGllqsuRF+ZzU28LB9mycAowkPn7xRWdLWp1pLcXJfZ+tHAmrFPzvUoT/R5+lb/VO9wf
NwD2TNCniVn9c3vEa5uIJqNMRkh3j3NzPklpAgCY4Gr13pamferrUc12Y4RjjRcHKrRgJSto6rYN
GrprFuTXh2ZYMIkK+1/8/R/rOzKjykC/6R00foi/kF9j91fTPaxrpdljasTKg9Ff02IX0e3sSQrB
gXKLKDah3ou59PmwyTTZeYwX4QmxCvneQMRmBERW/LZpqbVumsJxBYhrbZDhCNAaM/92PwPRow4t
iGo2tMXlrLu+laHUSuWpiwIVqaGmPSmR0m35M98r0at+U+pJO1pZHa6MfLHegv9ggXiltcGCL6EL
WjEaDRJz1SkO4hztAUXfVkNf3GlDFKEuUgaHKEvrlUv7ymqDbAIbhMggQNZlu6EqSxvp+aY+hTWc
nboIqgfE7uo7hI3sLQZIyhaz9nKLk2b1VR9aaeUMX6aOdM9Fd1CYDOjis59/7TIPDCdHw+tkoi3R
oWUgOb9NMK/zs6xNs35nkSzhNGoaUkPqEuX5vYSbt7lPMOhcidcXdyA/hS8Oj0lACIylfmc5Jjof
IGlOMKbwCg1mDX/GKfoZK4OxUnH6rHecb3LGorkArIy6HrDF82kHdYwIV6PXpzQOS8cLSGu/TYPV
KVt84tDu0St9dktVqEjN6MAZAEUaUXkKI/j9+ijFDb58KVV7wh6sEnyGAnxeY8n6ooWG5O+Sph8O
edvUspd0naG4ZRH6iSfrMboC6I926EXBTLe8sEjmb2kDJfIv4xaLSeGFOxekkfCQOJ/gnCKw0CJ+
f1KRBd3MhXAuM516E+F6tm+78onsrlyhel5cfYxpG4JpB6uMBtoibwIYCRzTCtoTNp2W53TCMnyk
ozTPyL3Jdvn3FWIxoEDDC14AuO1FqAJh5NS+0bcntEj0U9nQguQKkHaBJUsHyoZAXvquirdKPOeZ
F9pah3oGPsN/vdTMmGaoaAk49JvPl7pHoqIY5bI7gW4Kn/ml37s0Cu56fcy2cler936rrkG6Lm59
BLlx6BBRGulmY4n2GYMYBtmod6e0QonaKzjZIEkMBFS6SdYPg5XZd5qKJZ5L5enj9nw/yW6Lw0PN
hxcX/+H7ZSy/s1o2UKr79ESNOnwbEjm7t8e6s7wqD3Ikc6pm2uG/i+ZTm4XDw6g49Y+wRZxJqtG2
2neN0sGe66Xi3wEl8+cYI/Jdh0zJPRK9gauVX8JiJ0uqcx/D7ruLOuDUK3nEZdQV8D/WjheMeJ8v
TkcyyX2N10x6MpIp/t7C0HpokSpTXR0ZiK2UKulG6WgvjFYautWsqfvbS3jlpMAuobNCYQKw9pJZ
4bR+UwRykZ1KWwu/VKiGPYUS3qO4/KHRE5TWSmVJvbJfVDQILD4YMrrq8pN1aZJi6KLkJ1rp9UOj
Wsk9dg89So7z3GOzphfPjhOEr5VqZZ3r95MseTmyRC8J5NWnFGGhb9Ncjx06aDqk49mq3inYzxvw
7c4mNcx2A2xReqGTmXRu0aRd4o3G7N/XuDt90+CJedY0o7eZadxyUVbpD0kS8p66vayqSHYXO1M0
AXkEw0mmU7Y4iqPkIEtaqtnJAY2Mkw/erEjkm3WRu63RDD9ATDnoyicIxtCt04It7tNJuRccdW2H
LYndellfRv80cyl9OHOo1zvoabrhjiWVDwGXmSI35ZgdAO2gi2SpoflYqmkuebdnsnT0ACSKpQB3
IEgLUDP0N8+DSkWnpy7w0ib5iep6q6sxIoQlYh6eSun4frKcYtpAITee6GjEiPHTstgjz+q/YjA/
vTSDPvzUZFpoG6ydU0Q9s9ncqbKUeqiU/Hf7x14mTiIM8HrlVcntvXTy6GmRAMSoy5OZKtLHVGT9
E+gQ5Jt8ktXQb5L70vCzlcxlcYSFarEOMBqPNMhqoG0Wrw/Q5+BaK90/gNeodmAGlA2FigJZUQ3u
VVNZmx4ZqzvkPlBY7dtoe3vOixP8OTxlFhjQ+HtAul58n9hPG/gGDjKYWpLfFTn+MomSUWyx7ZBn
QuisjLdYYwq0ZCswo7hg6UPy4DrfD+U8JX7RBil69Zn8hGBDFnkaEIw3CUmt2MNy/r9ADqeVUZfY
kM9hefbwuAOpqIAMPx82822TxutED1+WJ83VhqS4s6c8/hoWQ466ETzBO7O22GZGq9pPSdbDQitp
Ofwya3Skb6/51V/DkQAaArrYlJf1akPFbEtgxA9tI4WYfIyZv+27VHvVJSSuXR8SoVCPcuZ3+rMx
0Xwom9jDkHmOnyl1tytRdRFUPxeHBjkVIgqvJCGLPWCWQ9fLmZwd2mz4HZlNv53zGn2pwteoGtFi
ci0V1Uk5VBGCur0UIpD9EejE0BagDlA7VOBEFnv+XVI8D+UaObaDFFLaNUOlmFziwj8698rb7aE+
64bLsWgSYK5EbRlo92KaCC7lXd8lBYr6YbbXtBTafZ420Qv8s6J4bca6+D4NhmR/63qzfdMkrUBw
Cc+XO4d4BYWgbJXgQ2opCB91ChTqBkhgYbgAlqvfg9lbb50WJspORvVi+nb7x19bJ9JgCvFkSty2
Ior88YZOq7nto6QpD8OkTK9NFbzHU909ar7pr0TsqyOR/JJM2Lzllskv2r6VLeVBeQgkWd3NZmAh
/cqjbpuVwZCsBL8rOw+8NbMiEEAIWqKWHOiQmM0r5QEfdwDGyLgN4x5Pi+BpkGoFvehey74hT6CX
PKEye1jZ+FfmSpSn0E+B2zYvC/1yPFNYS8pDW2Xxcxdm5pdmbobvijxo97c/4OVMGUgh0+UuAxix
BBxKRd3rzZT3B3J6lH5bqzpKuWTsSSzSR0kyw0fK+m+dGqyVnkVAPdv1NIgJNDCOCPFcNIudU+W9
bPnIYyKia0cPWWdhaCae8CtLeRHXqfdCBhd1UgWxhc/E7Y8N2tqRGaly3R1mK1W2Y4shfR7U850s
TZLX1nVzPwbV6faaXlyd4iahI2ZDj8OybNkxMXlkW6VplIdaBSju2W1abQs0SF/lETdMBLwK60tR
1gZ6yX6AQFZSp+2/t3/ClWkDR4PZxXtRmH8t7pUGQclQhfOzpxVjIQY9lLjCq/N8jO0Bq5KC0pSb
dnm/spsuP6pJYcmCnaKQYF0QFeQ8iY0B1atDgUF86Cq9lLxoLXLqt2e3BD4IyRk2LZkXcEoaMctS
khSVQKXwxj74ci6n26GBa7LtbA2z9hlIS/Fez44yulMUR6hSO5Ei7RNbzdvdgFpX4Np2mhftfdmN
kfL19k+7/PbCUklg1AEpOyjnnwfEGkRjj7pdf0g76npUMCs8uvVk3BNrcs31nTH57cf+sMW5pdxr
LWYbt3/A5SfgBwjAiyBUOtbyzS51aNB2RjocFDnQ/tUmSetcKdXnvz5XFIiB54mCkoCAi/ztj3OV
mkM9NaXVH3rEHr+nWvpOicfeAr8sH+DUDfdCzHR/e2r0Gy+ChiBn8t0Bb3FdLqt5Udkif2qqOK/R
Fz7a3Hatx8eQO1ephAYj6MvhtaRcbntmE0ztEZ/2apdjvjVtkOig4DmyaaMnI5JCYIW8X3h5pKPh
acYQk/AlTWNtMgXypYcGKFqEsKd99PixxtZJxhqcVC2rhj6XxECoxqxVjq0i5z5mpaPdZ244++kz
HNmw/JbYAPnoEkxAuK2+7V4Dx8z5X6G6VX5DRLdGP5TCp/6qm4XUPXOs7Ps8mhLlh4LTgfN77pWG
R56kwSbqon4wHwT9THHr0axNt1eo0PO6DKHIoj7Zssmkoj2h0FG++2XnlIfKKLSf8FcaqJtZXk2q
S5RQ8g38fNPwygprPrq9XXpXjmWbn8hEpd85qs3OvfCWRB6SZSlc+JHICfbZ+F9YjM6DnmMZ5rL3
WhtNcWt27npwRbYXGEr/4IyRWrs4ctRvlOGS16Snto8ZuO8gwd83AK19ZBnHuwIT5FcJbhfrhZ2A
7iJE2WGMgrdSeJrV0VfBoenx+DuJo7CiME0pBC1HRPD3Or5KP9PGGNC0ry1NekTKuv8Wo5Bafaf7
23/x8Sf3N7woS9XtrTmYn0s4ApWrqbU1fFEhikguFZ/om48UW+IFpp8mW70qK3uvVC1+jlWc4frW
REOIOYkRZfV/LBJSuxW9rtzrYptCH2YD9g8/TbtiJcdZvkqJa0QNgVEn64BLaCzqJjOStCYZZ32w
tUF+D2284d3IRxXUjTNwZSqS7ZMnxZnePoIrGVXfQ3dHbLCyk59Twwmw6vDbbsSQk9rsLmuZ/T4O
Z7R5XJOHDQLKjlbOfx+O+eE81RCgEwYvS2PQxI4CKhpRc7CQGduYGPX2bqbGBaLxXQeu1Rq/IktX
4AxVZ08NNpEwlVTl0Ca1/QNU4LwGjLvIn1hGx+bC5xqCFuMsbr8eiZysVc0aJXaMX2NfR3ZxkgbU
rAJlWrnylhV+8c2go3HdCcs10AiLpwK8YtTqrbw5cLz5UNw/44DCIZhK+u79l0xBZr22eb9aaZF9
Dccq3PkpEKmVvXNlzsgwEDIJ/Lxclg9Yh+dj1/sNNnrNZN7heNA/ZnUTbVOtUFaGunib09JgJItu
Ctk4hIrz2K+CjybxGPRDVqvVS5rkGTX3YCIypEVYKV5fhuXH7dB/kc9AUOF1wSIDeeepvrxuytxq
h0qtDroSGi9FnBV7QOLSo1pk829JCpCKB6q7tq/Fy+ssRzV14WknsLMC+b7EqsV9ruZOO+lHHGgo
9SJ6bv6AaNSj/WrC+1Pzqgl2RmQ0tUeKO/0zxGi6bKa5lSLh5SGv3LkX624iV2aBxAcMyNPgMyv6
486d07Yht7KMY0PvZj/zbNm1qS5tFLWTPHXs17D4F28DMIc2sFkgZDT6SSrOv/Pcm0AX6lA/1r1h
bLkPhl9xqtbKbsbFsKDj0MQvQYgW1WOeJcg6/eUnF6PjS4a2CJcfrKTz0fWpCUcFF5mjb3CIO+TV
kCCoh2NtGIiNIymbfdGdQpJ3t4e9ssi2UIZEq4anP4Tb82GNatTsvrPVI04QjpcpdlS/pySKv9Iw
yOX32ETl8PaIFymjEL0ArgfbQTQqlyDPKcRAVnJ85WhFk/pul0a+U2ZFvWsmS/uFbaODYQ02NwgZ
6+qdTtWtXAFnX/nOMLJoRcPnJH4vGUHB0ICmUjXlWENI+MjGTvsmIfy5wY1Ouk+yUd6nZlA94hRO
w+f23C+iFrAyvi9ubJBnqLwtzrXatRl/6CjHZGqnxsUSdH5Vawfh6wAF05Wu5GWoZjRATuggMB7w
08WGpk05FDDWlSOHVUjRSkg9wFBX3ZAcd5MT1+6hh+W/K3Tgv2EnqQ77UR3jv17u81+xmLPeg69H
2EM5VrUfnIzCJGSW1qzhyeKP83dkeHWvzIKghqeWB2vu7NdWHBEIsPAI2lFMXqzBlCE1n4+s+Nj5
dJSQs8diRQVPSFvDilY+7+XOQjATACGgf/EUXmKzg8zMZLMy1WMoD4l27GQbx44iC/bY+5kRhgp6
+8uXkjl6TP2iy1e+9+VRpnJnqAB3+Ni0aMXB+yNeanE4Ffhumkdp9nFBCpAGnzZTF03PVmlFGxoZ
xopIwNURBZoFvoGgXCyCh20MnVNQQT1qeVZuUwy/G1eWc+WldGoTfyxVvf/r88Mrn0ITN7KQ3Rb3
5h9T1DukFlCdtY6VAitUmwct22ZgmmUMgtpqZbArXxOaOQwHUjxKN0t1b1OSDdzdLfWYwHV8HrXE
/Ibq+nxQ+7lyEzkfECk0kmhTlL618vS72LWi2QTal7wGT76LMs7QI+xeZzP6YEWgNzs5GWUy42Qu
C9ib6Bqu7NuL70j9mx1LQEByF/zGoiQr47lEaiNXzDQphW1QtEcuKDlGAMj3KZpIf7uyoB0JgzR9
4ZHT3F+MZ9YxGnPYbh0NI5Z2ZcXJLJ2o9UJ6m1ulSJRTIoXRm5L22stfbiBGJpPQ4E8Ij2J9sYGc
XjJ6Q53qYxu36otsztpzAnjRi7F1KN3bY10kcYwF5sgg8oI/4oV+vlnDjMjuRHp97HR8goygTQ41
tzkOMj0gBoW3oKvG1Vot98q3BH3P/qFsDPpIW4waRBBz8mBUj03WGoHXDJH0WleG863HTmCL3FO3
snkurxkwNqjA0EEhFMCMX4TYOYxsUwLGc5R8Pf2KB4Jf/zLl2FLYsmZOsc81Iz1+9w2hAZSBRtoj
G+SHDnWpqFhVGbw8OhpPIERLeKXQil/+GjyWOFqhPR1rtbB2ciacP4PpF2nbWry97B9Bc6ZNQ0WZ
uCsg6ucfuGizLqwtZT4G1BCyvTqbPM572a/u1CGnvpuP1Mo3o4ZgRIWQTf0qz6QzmKYU+jQBSIrL
+O32lrsIWfwiNEPgrgq9SZiO57+o1FPQ2VhUHcuxDVAeMpUm9fyIJ9IRRyxk+1DvtiMvCPOovct5
eduvt3/A5Z4nUBK1ALyBorlAck+ZPQW00MajjiMFEHogMh69jNS8n6tI1XcRrsrDDwhj2moxQTw8
/3i9cOlBm6Phzkvts6ennc+dgNUavBeC5w6h2vmYWnwC65h0DfB9V8KdENGYbCiC5OfY5Um3DYK5
iJHNSxPnmxIjiu5sSsNoMXBgapayEtGXm4VPIlQrhCQkOA20KBe38yiGQFt2eA7aydGbhzGXeDgC
AWsb694uJJQNZS0LdQr0Y2Aq29kfijB158qqir3Uhi1oOmLGvHZ8F1uG1WLLkCARMUgaLvCZ/pw7
KIE5mFJSyJvcgUJ2cx8C76g3tYnqXz8Z06Oh4GG6K/tJzf7y0SnGp7j5+YonHb8QZGvosSqsi/pQ
2Vp5l/EZTC4D0Me/+twK7tSyH9OdM6VJkrmpMuTlHkEveULW2R895HD8dCWeiTPy5z4SP4jXCaIB
XIcqx/p8H+VpIvmhFGsPKeZr9y30l8kN8dVaux7EBz8fB8IS/RLbIlCzKxbRI22dyWxSsDlWKuHk
hwPcmLgIQliWl+Z4Nm/7LC9ML4/mNnNBu4DLqsYG9OTtE7uIl6w/P0N0MKg4XDH/7mhvV1oh2Q+J
gb2Tm0n8aLeukEiALgzfcmW4y+3GcHQwAGXSaIQ8er66TmrATx1N+6HT1XFnJ5NS7HXJxyS1CBOv
SqNxY0mKuZEbJJlWvuy1sSHj0uWkmINGm7g6/8geo67KyrFP7QeJlz4iRZSu6Eb5g7oHCB1I9zHv
PscNoyn/BtcTZafbK72IjWKlQRugw04bgaRu2TyGIRb3Ew/SB6lBiE6HebIhYhm7WcLLoJ4m6b4J
o7V04Mqc6R4hjC7UJskJFumAQsA3Erl1HniOx9Um1WLcJ2knTRtTj+Jj0AyY/4AKf9HqQVFXDve1
GfPaxZkFZCWVycXgAS5DAH2YMce03Fq9k95Psa89mrJyavKw31JBt3e3V3mJL4C18Gk/Tjoi2ud8
7fOvjAtOMM7zND3KSaDFmynWG/sfoIXKa2HoyHUHRu8Iab6+N19zOZmCj7Eu6VPSh4m+ZHZqfMOf
NE2/gmTTRy81gsmw3Gm08uDUmp1fl+4sz0rnOXI53eEVMq/xGS8CA4U/8gngETreKkBBzicwhnNa
6hJIsM6KlcBVS6WxXulvKp3sWTFiMq9tBhaLlo0/0gpKhxApOK8RzKUVBO5y8/CIFNRf0XvEOYTt
e/5LCmfEJ48q+OOEKR0ezo40z5uyUIbe3EnSNNyVlTU091OO49UP9G8d7M1uf81PO5c/o6QgayHJ
TE5DHi1IE+c/AVGQHJPgSn5w0OMMNp0clQEypUCD3birLGnjB3NyjCdZDvZUNZU3xSgj29NHs589
rOibGRPOwQm3k9ZA/BoKzMM0Dy37IX6qfU5MRbuosPi3MtBXH7H7aOzuc79S82d8v8zR4xeYzWsZ
hKG5TRWs2z3KLaH2kvnDbNyNYz9+GKXSjXvL72TZi5u66+8CIyv6baCHWui1qhw8N2TE4Q7gccsf
pA4CE7Y2A9RGsKxX5Yp+VmZv8JjLW5d0W8KMJkNykJ/TjHT4MEYtXfpvSbKRjMbC17EHr9ts9WFI
lRcwyOO+DpxgfFa0RkU7FN6vvhmw+rO+x8M8v8ohcC9XCTNoLrc/0PKIIxYF0YzbkvyB4qW1iKmY
SVoheqfhA/rNsrIz1L56DipNempw2dsYWVYV9+Rea0XExSsHDh9HW+xJHS4WdHixc/8I5docDFlj
lM6DrVWzV0hJs29ygUrPp9F8SfDT+8uGAyOSH/HQF/FKaIgszkLuIM+BPJTz0OWGvfGRQH7pWmPY
kKDhXXt7US+SRQZDZhqvGSaHCuOy4Z+MdJOaugwfAYvNyn1iREDAwDzLmjvTCZwoYcmFvaniqRXm
iRYmzFY7yckmMsLwKI51uhIKLhecXwQ8iK6rWIMlj6bxbbrFMLAec7s2/plwPn/jRTvSfhEGUEpr
rVXjl3nJ5xIQByE802ODP3n+hUmOxgg2XvBYGFp7VBl2RwcwOpjDaKxcUxdDoXMGIwtSn1CsJbk/
H6oLe59niak+1AABnzo1Gp+kqo4w2IQ3cvvLXg5FfVf0Ovm0gtC9mFXd21Jht4r2gElosZ2cWIk9
zamdRwLbJK0MdnE2QdfRSiC15ItfiqfKajarOe2OY4CT7VZp4nlfKsVwMON+xho+Vr52vbFW4l7e
XoicUZujkcC7mO7cMn3upzrowDmZx9SJKmnbNpWz7VvfMN3JJIC5Utk6exR6EVvWw/G7k0/Wl9tr
LNbw7MogxxLCw5RgCQ7mkkAxDnVXVnXaPcqhZRabFLX79CGopmz6eXugT9HH5UgIuznI84kiobH4
mlUAQTDBp533EfB3r5k162EcMALZlJmvfZkKNG7calLKkFcdKiFeMKiZtONjURR3YXGb0qvSAQl/
xHNJ4bGRdgNGhnqBQ7YdGzTtcVM1nfeWBzzWWyBc3v3A0XprJTO9ONysGEKvCL9RBQSFvJiHUtcd
tVoInpRL2kPXWMozckjKwUcn9b+ultZAO1fG4z4X7BZiKV3VxYFT+kapFYxVHrt+LrxU97Of3MXq
5CZa9iUrC3Plkro4dZSm4UUIjBL0cjLh8wPeSLHRk5+2j/aMVmYTmT63qZnMP3kKdq+3N8XFoRNj
cSEC9CN60Uo9HwtgjBOjStY+ylWtPirxKO0cO/aPSlCpu6Yzxv/UcJxWPuDFoPSn4SmA/eFiYszF
q2qw8JfHghgxSmueoUohK2iqQ3KndCWwOzA/ltcnRfLj9lQvDpoYlUQVERVqTXSrz6fqT4WK4XUr
P5bKDNBQMqLpO+DDcH97mIuvB5SKNJDdIryOuILOhylpmukYVCiPVm1j4armenYk6Jkv6mAp29tj
XexMxhIbktPMrCjqnY+ly6TUEc68j2Ok5wfOgLrDlGU+GBGCTlgH5eX77QGvTU4UEfHrAFbGS+18
wFKOKIzFPcbQKHXJLrsXAfoZ5NUelZZhbZ98wobPIhZvfO46khgWCKDk4qTDxYUlOBnJ0+wHur2J
a+rFm9GJO/q/CrTguao0B1Fpo34vSjP5ABGE+HGAroXhFg5uHYgLO7iEBGP7VQO6VHqZCedKhqU+
uBTeLOkHfgVWA1cGp6hfzZixFafaSvsfpKZ+lu/SrsSguE+77H1IBvtrPWpkwXI2QQvAizoqT2Bl
JfyKbq/zkqJJ+U0VFBhIsZxO+CWLGOAjygHAIVAezcSUG4dnU23PWFnxfpu2gRba0dHAD+iZ4luA
OWQQ6F9ircSDPdZ57tAybbLuAF+7VPdJNNrUnmLDGt0sSxrY6kiIOdgsqWryXgzIyuXbmrb68JCl
SFo03oQicQ3pOlKL7mvRsHzfyfWVaOM37SitRLtlQf6T7APPh3BAuIOYutjEo5qg3RcaxYl2Srof
ycbve1yUj4LZ/yBr+fyeUKTEOUw2DmOQZl40Ye58e70XEUn8BhHfIZiACOLdtgiD7ZjJhQxd8VSD
dnMRkkTRcLDT71pXjk+aNrUbbgZ/pR8psv4/dvfnoGCgLBAj1Fcu8GSKnvKkrrTm1BdmvR3oL0NX
KqZ9GKpv4dTNewNLSzfPpn4l/i7CBgMzINRFKETQW5j3+Sl28GfulKYYTizusG8bLdgTSKQtNu8/
s9JuViLi5TxF5Ux0OFSaHM6yxwE6nQCRj/3JGYCeWibclGqyx01hhdom0NL4pcF892VwurUS2vJl
ImYKAYJDhFk98XhZnACqr6Rj1E6n0nf6Q4ebNfU63aGBlipvsi8nuzJNMrgyFRlfLNnTpgkH9X6U
1LVH0iJy/r9fQr6CeAPZNBX58zUPx7nKiqEdT/44qb9b7v57Q6vjU1PhGX97My8Tvc+xhI4AL1yE
QbnVz8dK+kgyU6OZTk4/OhQAonmGl9ijY+gls2WHblqCQKShlUeOGxnl/E/XK9hAtD3Nh31YOOEb
CY+TeZ0fV89aiVLiJipHTTok2ZD9MAxUEN1YVXLd5ZO2gTd0vvF2exLX1gudHbrnougMbP18Dpix
V1QfjPHEmtJ1m0rwIBipTuUdOlb1SmpweSAsSkdU9blN6cF9Miv/eJ+HfVXMLZTKk2VFPvIstZ9s
52zGdbK3WsxtKtUe1igW4pCdn35eHMR2soVPhMDiEBpBn4LX7JRThv+fp2L+vuFdGkyuPMn2MaxD
5S6vULlsE3UOKMIk48rD48qkAUFQXRYrjLzc4nJNEZoz0aNVTwN5/jZWzeIhyybZHUrZ/C+Kiv7r
7S96GWNpPZKyo9MipACXHCHVr6s5RO3jJLW2vzWtJPMaBt2aSu3spKAMNnaIQPvtQa9O8rNzDyjP
pJh/vo3I2pE2Bp5wKiGS3vm5ku6zLmufjLkttznbaeXsXW5bwAmincjORf7/4iJpHSmdIdeeAnpA
H/CC2sbVgk55mcYeIYTbk7u2hehdgoFk2wrs4WJy86zVedJoJyuvlRDGhEPdbUAWoHaJ+9Swi5YX
XaAPcbXFjMD6kkWS9deuLg7VHxIVRBC5VjhF5z+CPmKJzo9mnsBkKJGro7t+NwGV9IygkCe3azLk
FoxVuYWLS4VhbVhPUIeEhMcym88kREkN+BunfIYDYPJEpTuJaeAmjiXjZCFXdbQadbqz8SG8v73s
F3vKEaOSooFAJDNdPl840ZIUarNxQj86/oHZW3xwJt960Us13w4RBkL/w3ggayjAUCHh6X6+wvY0
2hOXuHHSYz0nbFu0ZsBixNGT3RfhXY0B6soML44qMyQpEdbwBAhzKRCCAA7UDM7qaZSk4S0vCxik
qPvvJKWmKRPm/VsNRGyN9n1lVBQJBFMRHxEKIWLd/4jCSTYPKRBd6TRF1psTBr5XKEq3ycRbW9gD
/c7ktlmDEV8cWEIwTyg6yvhEEI/F3/8xKE2CFBs/VTrBVch+lq3JPahV5VvfW9bb7e94uWXFUBRk
RX2QQLiIRXYi6zxgBunkm5F8LIewvNPGUP+oNTyfBl3nndH2vKcQ51vD3F8dmrYtKDShs7Mk1Bd9
2SljFAYfGmqB09c0avSvjpHh/ppCkKmQgJGMneJk0FHyAVbOSqC6cmJoUFOsBCgOknVZZZiqWDBf
6/BDj8viPzufusM4WtULtFTZIPmy15xIrg4IlhSan6i3LzUh9dGRBqdUw48xDLLQ7VWUOmDSfEd+
MnclOTVWDsyVXSTEJxmJ2iVMi0W2kra1ls2B5pymMgoa8iaSCU/q8GtzM50QtLKe14bDUATFx0/A
37Jm2JvYGE6a5dOW1JKtUdFbdGXVl+/Vekirv71CsTek7EWpjdN5iTBISxvPSn+m8YhisHLfjb2+
a1tkPz0DnRJjYzZltb99Uq7MjyF5GJGKCYyqen4oy8QsSWCj4KM0OljuWthL3+q0GEfQQdW/t8e6
slXQjYRKgMscZaElNSOkGa1Z5RR+1IlTbmhhJs+gwJK7dmrjHfjn3//DcKwjFUydB+eyMSNBxzcm
wvZH1c0xWo5xqx/UuG53gWLMEhw1+Cn/y4jCXhXYBCWbxdsWqcOuVuI0/EjVImm9Osii/tDEuaVu
6jmPE9xZEtxwbg967QvypBbPHVaX2/L8C/ahLs0JDc+TFKeS/Fjhh5l7OHRN7Q5urrF2JV+5Oghu
n4ggNAkucAPAMZswc7LwAzNZWpY0Y6R8VzuddDfHY1U+oo70mOAhssL5uJylyqngWubs0/ha3sxK
Vke8nrPow67VEvcF5K+8oh65qZVp7RheHYvYDcaWCtxFFVotlASXoCr6CPJQ3QMg1nZAxbtH5CaK
lRN/fSi4BjKDIR2wiGZ1a+uTVtZMC/3rYjMWsrrFCMF8cWS/+ftYxhoSqv//YOLq+uMClofSlirZ
Dj/KeBgqt7D6qXUD1YylezvO12rrlxuF0WhVCjcDkpsl47yWlM6RNKZWOr0+eV1gI86T4WyNhbdd
PM3IfRxzwsXr3x6HT4gjUUaAaS44b0oVhKI/HH1QPI3ulbRzPkAbwtIJpWLNMfzK16PgwUsLbjvV
neXlUJqQ64ZQjT46pvXmlBqwEN8SQglFqv/tc4c7gbIswZPIIsrq5x+vUqcxq4c5/JgyTX/A+kl6
TFv864epWXvJXZsWyByLZ4YwxlnqWDtoWKPyI4UfczhmnLWm0TGL7oYm8LgYrHAlgF1eC0IdC24E
ErHIyC03Ssy+7FQziT9qFBK+mEPxNoSmBA+jU16joeu+3t4glwna+XCLHH8yi9BAbSD8yIcZdA9o
v4zLZxicH3ZjVs9OAL/ntRlKeFYJP2h7e/SVyS5fNFKED57TBPGH2Uc99QC1d32ypy/SUM/4EejZ
yra5Nh5hkxuek0/xVvz9H2c+930Iitx/H05tD8fEiaVvwf9xdl47biNdu74iAszhlEqd1W33WG2f
EPbYQxZzTlf/P+UNbFiUIMIfBjAmASUWi6tWeIPr9PgDTtb3mi78Wvft6oJQaiDLydnFkpxXtHqR
c32Ij37ygs/qqOfPhR2Wm9ad03uA0N3fsYjQ34KoDWeMERAaISC8zx/QMzuj6oHLfZg0lA2/gSOu
PndTVA27vNPz+c7rKtV5HMQ4xxtGZWsix9eeF3UcKakM0BvQ5vn6veK0YQAo4MMtzYE5Ykn+NDnV
KcvV4ie7sdbEv/Zx2szuQVtqLLskI6apIoyoCcRHWtb9p3SQoo8GiL17O5zzNWnYq4vh6MQe08WG
jn3+cIwse4hRavRRKEHTHeu2r+71opzKlxHA4EqT/rKFDNwYdhIUOC4NWmKLs4orgTYAO40/MkZE
AeNftPM24ygskE/e3PoolKTfXJBDGz0aGv5tNgi/07XkaaQQW0mMr1xfkjIFNQwM9KUGVJ7nad+n
JR+OVtjW0Qi9kXlXFHj7IeBko+nRReKO1hqYq9shYqnqIY+05BVLYJ0uNUrlW/njmw3aTBhp1yYf
ca4H8bYK2ukf0w7qjd0knumbxH3+1Cbay40oylM+VDm5Q2t5L9Pc9c+tXq6B6OWLPmuh8pNAtvLh
kkHIAcP5TzLKzIHNFMQfeWZl06aPaYP5Jh/24fazX/masPF0GPFQe9MqWKwTjqgXWOAcP3SzHCnQ
VaTe57lJ0SqZYDh3VeO83V7xynVAVKTwYCpkakBvzp9MT7jeUXjPPtIwCx6niaklFqozogyBPv8U
lad8agKtgWSF0sbtpa88rIQwEpz5luW8/HzpxI7yZJzRzTT6/KNq1HbaaLaoMONTckSv7NXYfOUt
Mv6jDS0VqpjxLQbmvdozqwRs+6HHWTfsigqSp49Aht2uHOErT4ZoGC0BBEsp+JZF+phqIVDIMvso
E1MN/QTo49ashcRUWhX+n3azxsW/FjwgR9NiAs4B8HBJyutiw6qR4co+ahHo+9phNDs1s/6L7mL4
0Jq5uKP51m4Y6prWRs7lwHrO8T7WlOmf26/1SuRw6fGTP1FVM7tffL59pYfzxLv9iGrdU2iVxvFG
oKTHEL9xPoTq4HJoJOru9qrLLQeMCx2QyEmtq8I0XXw5qIN3Dt3S6VT1Wnk/FGb9EIuO2FkO/S8n
8cK/1UiXC6LywIyNGEUitFhwrnvuIp6UuZrhPo5x2N4Xw1yPPvOW7kkbPfGXmb1ckEpezk9kHbhU
1wAjFmY49OgnA3ns/C5CIOEXEj9Ks22SeW2yJ1/SnwFPLsZcj+yPBjTAWrndf8TglM5gjSWdegrm
JI23NFKz5pPiOWG0Nao8nVei0LW3J32UZJnHxHiZcgd5QUrlavMpShtX22NtmKVPiFcYX5zOc7dh
Yozt9vaBke9n+YTctTR9ELnial+8v6qPNG/M8SqBbDf7kc1Yo1at/HHoKRE3xUwJj1Je9pW2zXzo
hIcs9e0fsPxO5BYjMED7WSZO5BfnW1xZZVn2ZaydYGZYma93uvEpsxjGKaFn/uiVLn7tTS/9fHvV
ZQz8f6tSl0L1kMOUxdcZzp3Vz+2kndSq0nK/zKm1fLxOzJXtvfJGTfj8sgoln7lgC00Z7AJRCvU0
O4PZHCw0uvtth+C5OIhYV997fbD/1hOCZ5PDC6laSdsCzYrzHVXaDH9nr9BPmY41wh7jQsbwPrY8
In7oAjp8Pm25Qvl6e0cvYCUsy36COMD/mj01Fn0FY0Zo3OgG4xQ3c/EaqWa2VRFfypGArQb+NgKO
bsKo6ycz2tXjAAdPr+2V7PHKB8tw/He7X9JolqcpNhqtS6rOpC/spPWmce3gXo0YaPlWaq/xopdJ
g3xisN4ug0AgrfjunG80jkNjhbWscUqCafYeVE2ptiXU2tZLatT1LI/eTWM4xVPlOWtNxisHmADB
FwO8Ayj4UtRHlJlXMqg2T/1kdNkWuH9s7rw2XFMZu3KAubuhAP5Wdsc34PwZ81SvqF4ME7CQVXt4
EsTRARfZwPwYpjn+ynys8u5un6Sr2yppZ4yuifRL8H6dKMzCRcCjDUM4HZqwBBDZAos2/cAwlKd2
9lJt249m8JEO8xqE5UpARG9KwoPpxDFeWMQjyEE5U4eR+wXZzu8lCsT1YcwzPdkjxz88jMqQT/dN
7w2frDakGIgtRHFWbvErMRFNTyoOuo6ExGXBBXGn7AFpaieoG3HyOCl6qflOOmnjSx3ZiYZyd6E+
anWkiv3tvb/69DTsEE9A+Ayi1fnrFiGUHRRE9VNZR3ryogRjtm1U3Gd3RtoPziYUYpZZcF5YW4v/
WTJTIu3j9o+4duaYfvz/H6Gf/whFR29s1kr9VKlaewRWlX3N6JHs7NxqMDLIjPvb613bbvi/iBug
qkDeuLgMKgehuhC3rJOuAMfgak57hOEm/T1umRTupjScfmajZwcrl8O1dblTSJFp3MMrWGT+7ZS2
rtYnxikq6uZ7hKZx8BxlqqLsBbjIbB9MsftNl0D82897bX+56SnoDeB/pImL/R0aoOOlaZzoMzc7
uKzePgBtmPq6PYvdbI1rrkHXHhRLODA/EvYMfuB8QTTOGdPVjXlyC615Sryhfy6cIoYnUyUuvsZ5
HgF+p3e1Ztd2dWFkFkAZStHTZf6WYBycO3VhnJSh0HCAUv8dwrp/0dEjUf1SBAXun5Mepf/DiwWo
gFAT/QvEQRZfUWaOvWaGtXHiMy1fnbYOP/dZz8xHryqUOhjMjsi7oqD7l/wRwDzMKiS2U+pKINm7
OFFaFRViECoAFQNY5xZPOrc9qKPZIJE81+XwvzynVHYA70eVs3yvVpuGA4gf82R3UXpKSmV+hVnp
Bn6uzyWfah0ZuyJiFHW4fYCv3fJcfJB0CZISQHZ+noJGZGHSgkUx3XF2Nto0M4MSwssHELNpOf4P
j4lqAakUtzkYThk0/6wCcnMarTozT6owX9oy1E9t1RkHyklLzrYBRxvK9PX2I8pvcJGX098DQ0Wf
hWb4sq5SgKIZEbnwaarzONwDT0v3QYsfwkrAv7aV1KmAQCgYJV7//NmQ68Mmt3c4MZXi/MLmSU83
89ADFDUntR1XVrt2vVDegAyj8wD8b/FhhAGu3prd2Cd4R8GjXnZFti3G4rmq6w+ljNODRjx0H9Dm
1f0sCMqV5a+EA2IQGHfuNrrgSyli4EM4DjmFfWqmcbQPSh/YIRKF5nCq83Gu7xDhgCRnZmJa81O/
8uAcV+yJweGhhbScEQXx4NhQy1nZMocNqojGNoh10fptGfxHjmHHfhjqNLiGscA+YiyEqf79KZZS
sTQxwT9SjCxOcYw4fWFmqnMq4Joe+kzDVlAZGW1EnjWj5EqU2DNFXdNLuHLZMKiSmpDkFIx2Fstq
LnM+hDedUzUYqthVlpH06NN6/ylx2Ol+aQ/Gylu+ttcSvCVDPkYCS77eZMwqr1k4p04Zwq7bpGMc
/Si7OIu2at8Fyt7Ip0Y5eOZcYI1cO/p7zb9Z02+49tw0siVOUOISl3fAqOuTOqFkdIrrrPbndrB9
pRqj2rfi4BMGxtEaF3ptwUXWhKNNq6RTYJ/m0vHqnYo9kP0QgDPZugiN5r4Wh0q1ux2lrkQPSndG
hOALwdV6i1ZirTfjmOYVLzePyhJb6wY1uQ6Qw8YM226FY3olJAKbZZgM0lOyNBahytBHVKTNwDqF
SW0GPlbQwvRztx9XOhLXHorSCsgYMpUARxZBCklixFhgkJ9w5axm5BBQJHyLxhKvHjEaU336+z2U
qA10rqS4/vKgmGoK8WU2rFMxoQ/7ICLXaTZBaTPyjKvcXVGBu1JcySYLNAguM6BTi010zDBWifLW
yc4h7HBpgmfSh1b9nGeZ84/ldeox48r5hNrf2jV6dWlw9nCnaPVcSLnYeUpnYLDN08hNC4bdUJt7
MzHz+F4HalQ/6AhfwVyPJvFT4Z/XdBOuvVYA7iDi+MM1l7QX/B/6Jmlb52REiEVjBxR/U/vK3EyV
U68gvS/vGWBUGGVwfLhpSATPL1Udw4zBFJp+CtSwHjZK0ZQ/0Yixp32aGla3c1UBJVutcuawtw/T
ZRDQ6fqww7DhuGeXr7cJ8jqzoaCflC76IXQlj3b2lFb2m3RuuItqu0ZD+X9YEpUgvkqpI7JsWnoC
CXHHbayTNkzO28x4yCcsqtEmEQaeekDOft5e8DIOgL/GLR0xVjAlF6mR6s0w8FNhn/S+EP9qzqQ1
+zD1qjXpo2t7icQGuiQSrUaKe/4WLXAW5tynEpTbG9EuSRwxb0PTGdH5xn9jlwy5iO5uP9uVkwPY
hVYoFFHusGV32+0cu7GS2jsxbzWqfVMVjKTiKrYlTqcJHku3d39BwK3WGpWXlyblL80W6mBp97LU
n2ITJya6IEaDorC8DSrj4V4w2xR7twmN71njzttp0GaxUdSoM7fooiZrw9YrG/7nb1gOpiq9Qao6
DMVHbqnJMWxaEe+SEsvTrduhLm6S5gd/HQ5l1Q+yXbbd8YZYvGN3cFtI7uB0uXbm6BHbnt7YVMJL
DN/GRxyVvLis/XjK2i9B3HYrof8yIsrVUfUwUY6g8yA35I/CQkyUzAWtjQ89sLT3iQ5AsCGbsN/r
FkPIaszjVzLUAoH8zFjJBi+joRRuIUGi9U8RZS9ClFE1dpqatnIaacM8mgrE5yxxlM8taKDD7TN9
7bXikwYSkjyWw7VYKoUBOedjEn6gDFP7SKyEr14cTNtuTj/ro2e9317uyidky3GCVACBzLq0gQYF
o+ILlSinNI9wVp3RXpl2GZsvdiae5WPo1xNItNAZ7ZVJ7pXAJOnjLIvMIVXxIgNruhD9RDuIPuiy
T/Y+6YfQObSOsP6HDaX1i3gk9S99Ffk7/jg2vVHGRRVZ4kPDofbARTOiFwlRK3XnvjkIS6HBfntP
r71CrhUmYcxWpdjO+Yp11gsvHg3x0UJZHPYCeEB+8Kbaiu7gEDj1fYZu79vtNa+9RyZD5O9Mc6la
Fh9HlgRoxZvghPUW3YRhVsdNpmBFYRWt92Z3Vr1rzGzND/jaZ0Hnl7YYu8tUfrGoMkMu0Ss3/Ijg
wI5+TDS814WRvTU1hMXbD3h1LSzYKfOB19FlP9/UmMacAqYIzHw6VK9qopabANkab1t0g5qvnJlr
Z5PUi7cH4wPM/KIzlDsoGTqoF30kept9V7WkCA9tKqp8+/cPBUaEPJ3dg3sgQ94fZ7OJ5roxksw7
pcLp9zh2OcHGaNvQuLemuXHe/341jgaDAmxnSZ0X59Kw0C/QFNU79e6gIqPZxFHum62ai10TG9HP
26td20NqWcbrPBpwEPnf/3i2MSidKCXTOFkM91+QgAIABCSqTna317l2LXAR/4ZbETaX+heSvOUm
XRqcmHlY2Z0XOuKZMYn7PGuAWBEnc/MeHBQigN/D0VPrleWvpQI0R6haadciwL7YVFXtXWgxlXJK
Zs/NfMXAag6me/FYND0Oi6NX7dliccCIJGl2Wd7k/9x+/mtfvpTB45xKAZCLlkEYJWUQE8Gjrgye
A1htzwl1y1NuzSlTB6zemjozVr7GK/NLAOWAJFF3gOiBitH52zVzDY/UQHgnLZzq5Lko6sBvsNw0
DlismPj95UEWuj7iOLr+yLQsewksTJ0/cvQYft3egKWzD31cOmRgiqkhKAlpAJ7/lpCGa196RXDK
UoxN/JrtvoMyXwYoI2jtg9p74SHUkhYz1Mk6KGSq2YbSVNsFzMymTepUybay8jXWzbVrABslvjZc
2EBmLYJI2OjWzAQwgFBVZOZ2bNJquC8TVUDwnsLuTsG69f72Vlxdkk8ck2dOAgPB851AObcL9cJ0
TmM7I+qmGFX7zM8b3J1hjgapWZRZX24veYG8k7cqUAQJvAO8Sj11vmaJWkWeDZ2NS3npaqdI9bAY
5mQo2n4Ejtj4MCx0wy9CnHfuk3kM3gJPRTE3KaL83quCMf8wlA6Dldu/60pY4MdIMhvVuzwh5z9L
OIUXGFYYMLYp48r3pqzzNhMV9KntdSXG+VC3sp1lpK71apWNsVa/X3kVUt2L5gvCAqSBi7c/Ygrq
NliPf0xjYz3Tbu+2du3mGzOmYNBsa1qDQF4JRACoJEUInS8V4uf5AzuN1qr6qAanDqxg9sPMy/5D
L4bgrpoq1XtG3SzGQibMLPtVo1/hbao5XLvPrsQiBowUmYz4yV2XQJGc6rAP5lk5gaIIom2VeyqZ
eQVi++eQgPPdJLldBb41hZgv/tX7/i1J8jtB59QjvbsMg0j2NIA2EP+akqj6bMZ2pfqJomp3lQfI
d59WNBfuAkfqNkOLsef97eVlmP9jAiGXB2GA4i9KZEjdLDHjWGW5IYls8IwMVYE/nt4Fw6aXRiPM
yPF/ub3a4nCzGnFeggwk+FJOfs/fdaU50hqo0J/LQuSbqUujnWNG2d5TYnFnuUlx7xEKtxDF6pUS
cBn45dKyK0S+Z7A0WkLnS9vd1IRdNOvPdhvGj/VYCRpSkb1pY89wfMAr2bYsW/25rVTjzp7c1scM
o1lrTy2+Ln6FbMjxF3ghKFzLkJ9Hamx2cW8+Bfh9HJsOlY5AkOQGSTFtdDzM1sjsi5MNNZbOtITX
SuyXDu3i/LF7j45CMbWkFlky/6rq+OuAxsV9MlKEZmlrbuI5du9uv+WLMyXjB9BeEkSwid5yPila
VwmBrcfPQ6GIx7Ab7R9eZ38TnpetNIsvtlNiVuSDwRdja5fzs8kITLUe1OR5TooYi2YtKKutkQ+T
jcxO2H2DB9uuxatrT2dIqgxBS97c8r//kR92Zd/UjLiS5zRu8/s57BQciQZgdbjJhe9/v5OSCscw
HUIHSMjztfrIbZootpPnMUD0yg017bsBNOWHkYt+LR+99lwwnNAepjPFu1t8mwWrZ6GpJXybJdpH
tcXwylW7e1Cz8UoJfe21UaCgmEf0kQDP88cyo54rMMhSgk4pj32nPoshjg9WjPfLLg61ds10+vIz
INoQcViTtqm29DY2jJj0uuGlCfrTXywRu1/cwG0CrPvilq+/mFF0AE22prV1GXY4oXyCcBzo+4M1
klvxx2mZ1JRmsOvwBr0++p5bibnr0wYkNuZ+7b6cJuebrXia2GSxOX9jyDJ+0bHl3t0+R4s7lijA
rwBmxFiSNhjYufNf0aWW1U+zYMM7dXxV2Xkrqn4m4dir97Vb1D714mxs8eMJNwjRrulPX7xvcILM
I2SrE2P1iwHSTDNVcdNhOpptWvSPKNia7Q78XlxZ/mSoaUjE763AXUmlltaCsqPAPBYtPFYFfvMb
R/7H5retqMwaTMrRSUTl2n5eKclnw6jQhNpUddkXPZllhH1MS2f0kyZt4x6LwIKJYiuZrW2mwI1/
4ntZtH7fF4Nn+SBNneHByax0enICoZs+TaLux+23tSwM+N2/q0LIxeB2QIYtemmDU6Ja3Vfdi8DQ
dFtMU4eLQ9QXPqmn4W6KBhtHp1GCx8jTlM8iKbxD7Olluxnwb1E3qllE723Qhiun6Ddp+yxZ4BBD
VkHsGQ0LyZE/P0az1XpBofT9Sy+mDhvRPE2jTdoq9jEsRdvucKyp/0FGLWom3x1xIW1L22yoIGo3
3miiLMe3xIKWulGF7sVHbYwVbSViXpx02WqFxgOw7HdWKTOQP165KDqzUNs4eVGnsXQ3kaEjtdlZ
8UvW4G69LeKhMfde0Ll4zLtB3RxsNNLWADoX0cYmx8HRErUPaAr0Es5/hGsVA9oMdftiZ/gGdLBG
f1hxpTY718vpABdJv81NZz7dPjaXj063EB1SJozgLi7MJVqrq+tesdsXcGbdfqyC/t6e4tH2WzwF
HKFvCiuLt8pUum+l7fQrMf3K6syGYAsBCya5WXJWi8Aexk71upfQU5EFbge126MwM+gH+ohq+B1y
fvtKNVwyE+zTUYqFoVu80k28CDS/0bIAgiUKw7kYPhYhkwdugPZFV+xg7yoRBZTmTj/dRgs2la7U
X29v+ZX1pNkWiAtEkAD3LT6I2qG7TcsvPjb0L0J/nGpTbLw8KV+1LC1+2SghJYfbS14GB25oRn58
g2SQPOUi/5jcuEDcvsuPIWmu609FMIWKT1KpGMjadQEe37YR1Xx2ZWaqu2xU7G5P6luXhd8BY/ti
6dQ1T0bSGQKPV7OK1HElUMifcB4nYFeRSkjVYZR1LtKyYog8vRrEUW+mLHsZmykELVZ3wZcEnbY1
JPzlyUOtiV3mYuH80WNdfG0aSpXjUJVHz8knjK+VIeJPAAQQ1z5XrfsVAWnDR+3Cfpgqoa5pMtgX
RQ2JPPwCGubSQxFWx/n6dZzVMYTb6FhgOXtM+tEwNvDsC/E62kEF2HM0p+5LBIgl3zpdEpcvUZ+Y
qV8R3L82dTIFqPdZ7hcCWh1uujnwQhzbKMf2qZpRgTTTZIGEdkvmg+UY4/JrOYU+HtxEL5ixWDlZ
6Aycwm/UwjBfcs75M/qe8VvmQcz3OyHyNxi5uneorKGrt84o5nHbVCg37ILCSLMQ8EODiSdMcBAD
TaB8jguhx29R6LQ/Auw45nfbiAFmh6HHyZmR1CCOVIn+nipO8AVvL894sOdxindO6gTpL/A4TfmY
MK0w/smFCtfNM9La2FqRGQZbmFp99ZC1Zjrsk0QWPoA8qnIP6d0aH0qors6DkTX5y2g0pdhYozM3
9wrGxMZ9H8dTfeQIgfMc+5ku6VB4KbAmJWwcCLJqGSn729/bldNFuWpIDhI5MRff+dvlMsnrKI/F
0Wrb4WGqi/Fdx1DwKaB5y9dnNtUvJamsCRlVTWQcs3St/X35C2AJgS2ihOMXAE48/wWMDDq+brIY
VFK7T7WSRu9RlLXb2lFhzjYpTnBCUc0XU5TBHiDyGqTscn2+YsAkCDtwirwljT2tnRlxeT2gEwrK
cx8XHrg9D52wdKO7iWSBefVsmx+x21XPHRpU6dZjkJys3Oy/2/znUYWCixjL75BMjOXgOLXsaS48
XRxFPs+Oj02qUD+7tdE8DUPfuL6mZ9kT97LzkeNG+4AuSfoBozl0P81c/vYpjcsyftcCplhfrRSx
+sc4bRRrTXD98k5wKdakzjRZJ1PXRThqKqRo0KOojhpGTw+THkPmjTKuJl+JeiI111bx7+0zuiRE
oh/kMudlDkMfH9Lcck2RYZPkeX1+7JtZG3aKOuTvwm3yelf0krScRhY+536iNSL+Z448I9vouTI8
D1pc4cGpGGFifb39m35f+GevS6aJ7AG9dilKsOz1WHOObsWQaa91UafeSxlEXfs6UcTrT6EaN8O2
byLP9tPc9KK3yRot5dlJygmHK7XoJXw6jtJ3NAaLYaO2PRL5eqW0ya6vpzz5gsvIUB7abBq897Hs
pnBXIO3+UqN8NX5C5DUb92VghOpKkvNbsnLxUMxKEMfjXuOP5YVvVF3idrlpvOLWPt+rUzj/63ZF
bnx29CA8GG3lxSdRVXyXXjQI78FDdCG9N9uuPRl2VaTbCF/FJ9tMTfNUp1H15Ay0Kw7443XKk5Yn
ffaPZwkxfcocur2bOneyUxrool9p0Sy73xLwBumED4rWEBf0kgIS2UMeO1naHdUGQT/4sUaBTq5a
FOGnfmgc4Wez4kV3mbAGHOPTrvJbYIef59AMjV3C3Ib/e7TbcqVku4g1v+tzZiEMZ4CcL4feIor7
Ls/68ZhnhaPdIQgYvsyiKh4CiCR0YdPsK5BpAbfY6cf3eXDFSupy8fXyA1gbvDmY88sg0wdxoQ+O
Nx7NDodIH8sb82dm18LaDBoYDbWN1uD1ly0CRo2yWQYUEWwKmkfn8d2IGLGb+DMdVbQAfqhD/zDN
YbyXfi9+TFnu+aOboCanOUHx2lDoPtM6WYMuX9bK8lfQ8ZetQiZynnn+K8ZRr4yWouQI3wwp4a6q
zHar5KP+oMDECje9kmvjvdojhl0gtZU/GqMbi9nvq8wYpXoKNMtRmY342bLb3twqQwO9XfNSRhaD
1UCNsyZtzXv2MvDxq0m/oP9SMRMAF7mXBscFaM9EK7UpcS1N9f4H90c274pOn1+Cdv7X4UcmQIJr
Z6c0Clpn8ZC/KYWt/CUEmi8KxDWyTmTdYAERnz3fQFOYYVcmcgNL09lHsfvTRBLkXcXP+CVJm9L7
21466/3WMofeA2V12dOZheSvte50JJzX+Ak082vZuObBFXr4Oepmy59Hj+/D6Wrr43Zsv6hvJWdB
EnpBXtNV+32i/yiyadnXtLF7+zg3ffulD5JGoG4eas4uYFD/ajTpfwJS6pfbq15+mlRa9HkZHbA6
zLnzDcZLdPTKxnKOLuyw3ldElOx7x56/Zm0TP3eV+O/2ehdVDEMpMnpJUZReAEuEcOP0dTMokXWc
ZxAwWaWP711bdxsU5Nc80i7D3vlSi0eb7aRW3CK2jnaeYfHnRjV+OioYmG1URcMe3UNxSLws3Y3G
GB9jA4bc7We9TK4gbNEmpG8PKpEEZtGyCAsEu2MGnMcR3cjk3szKsrmrg3pO/M6r6jtErcEb2bGb
/Zu3QwElBuzSfJ+2lfnSMzn6Ycx9/FZh/tVt8IEV+zyJprXpyeW5MyRsEaF4CmAcgeQJ+ePcKagd
jCSh+rFUBrTj1bHbqnY9vKPSgmSbrszpIWB8XfztlAHLMKksKHWy6MctZyi2Z4x1TIZ+xIBZ3QSu
U26ayHTeCjqtdzQawvvbL+P3uPEsy0BlARFeoHQ4xcsx7Plzeo0YzRK+znEirmoHSFCe4QdJamt+
qYLweYhaFRVtV7XHe60bQBy3YeMp3MhQXzY9ogXKJhZW0B9wrdaOVFHj8GTMnYJZ2GSqv0pduNPB
afP2rtPUKQAmV1SJX7mjU2SbQFfjbaEbqbcDKDVYh67V8DfTRdLDTxWmm/h6lk+Su+PM4bbRFSt5
szrLPCCj0KG1pSrDZxqCdf4N0K7+xTRmhcggqVd+L8rhPmr7KXioQdl9ZMjZvImu6YKngTK58Gt8
y1HrzofW+nV7Vy8/Z6QWwJnRHmTwAGrpfFOtpim6otacY8u8LNoGmRUouxyGPVPPrgv0tS/qoi3A
S2TWQBuELrT0sDpfDzCUAlNCtY5ah8nsxihMsr+E0YRfA5w+OJXTzAdtEl3mU/73xc7oCdf3oP6U
u0g4evttKADpoy83w+uQs99tBxpJ84WHOyCqJ4lGW6/JyNtub9RvgevF8SO51cGkYH3HxbLYqayE
JxUOSXsMQqCNTpXp0VafG/Po0DG13kOzUzag3xX9vyzpkl3C+Mp91ao2r3w7R2x8J4DWHOqSZgE4
4q7oE18FM9J9V7yi2MBWzNPP7Hg4r42XL8Oo5K9jNokuCg7ES8H5MBGdXeEqcuSTQGFNFJGv5o7x
0BRF6dee4m3zsfrm9RgUcIf89aiVqpTD5QAWgLZ4EZ0wfnLzZOja48TN+aZ5QfStAPuLdrUwD/PU
1V/qpu/XJAKuHDNgXAgaAYQlCVrexUqbKnPvOMWxGYci2KJwF2yd0jXuyrEJtqNbN+094TG7y8IC
/7jbR+XySqaEYCTA5UjD2V0uXpiFJVwrrY8ZEgJ3agWjbaO6AXkrbciPPFST77cXvHIDQC7mkrKQ
XQVnvDiaKFcVdjbF/bGoAKxtx6AY4cl3WYiTQjRsor4MKRWy5J/by17ZZPoekqWJoQq8Qvmz/rh4
2qSaZzfqhqNLoZR+8APwEHUcvBW3Q9iUzc+avov1nM9WXnx2gqldiV1X14eopPOADDiWaW5XKzlp
WNEdXSw0EoAgOEB3xgTmePLqIOXE2XDalQkZkkOhWOra5OfatgMPoXcu7d25fc+f3xgwHE21pD/G
2MpUYC9j4e5Ntw/ejBxVQ+jKCt3vURErjY0r50smmXQRCEZwNBavm0GX15eTx3PPYND0QcDkjPCU
+aEHgmg6BN5ainEl+EGYAlIgZ6ZE8AsokJ0YFad3OI6uI8aHfDTy/4jxqbFNHDtpHrE5SH4mcoR4
0FIv+HeonV7Z1tXYBxtd6W3z0Rj0RDkoea1g7hfaSUl/zLEzH0XZDjiu6cbovPfC3t0+o7+zgvOw
LaleNILohFPALvt0gx7rRTHl8zHWxPCmQ/I0tiVyaszyjaB8GsMkfo1C2tObGfHsaKfYJLjbue/b
+rGJIlEwDEX/zi8wrQFYiJ9s5U8eM+ENYl6ld1dC0mj8walL4zHXCj35KDs7GTZFOjr/qXOrnRAV
4PsT9KG9g1EMaLAOc4h99e0HvTwU8ILQRJE+nBKztCi0xtTRSsNR0Iww1Piu5lL6J6T6fM6g2m75
KvqVdOxKr4RxBpZjOCNIUq+9mJ63Gm7gnlr3R82tknT2u3yMLT8mhXtpG65k4k4nhke+n8jbWQgJ
x1s9t3CNtUQl1QG0Trxp9mz/+Nt9kF5WxEAafhLUuvgolQyzgrEx56PuRZrhdxjN4rjliYeemniP
+DQ2grdXvAwDrCglq6huwW8su1/1WHrzoAzzsTXr2B/MVH8IR+U9cEuCUqF26r850edwe9HL101z
RIrTcKPSfl6yyQu3z9waZfRjoRfTNs8T009GKExuqt4No1O/317uMk08X24RcjDewYUwGNRjPyFx
D6Go/Yb+9EcWT/rKpXKZrUjcL70Wilkq+WVCmrjmqKV1qR7LbGr2Tj8Ezp5+k5X+aBrpWJPoDQIS
wNmQvyzmxE02YkxG7y+JsFQ2NA8Qk5LyDtisLsvqTmSeM0WBdXS0qZ595vM62L9Q3TX4u618Slfe
pcy+CefA8QizcvP/uEfNyK2KHJGOY9On8wEYxYS4pZXid1w39j11Tqbtb7/OaytyaTqAAThAJP7n
K0ZBbWJMPWpHrVLguzpJdPBGc0w3YdaF23lo1jKUK+dHtqOkpBywH6b/5wvWYaM1QLT0Y97P47wz
M6t3X9XU9LAg0vXAXKlNZbA7D/qkfpLQJxVtwDMvdhRDOd3ra087FoIAkylI2Rzwaqz1lc73ZQYi
EYRMNEg+ZFWzgKQoUTkDFEr049AW3UZrTIY/qTXsM7y4N1RS6j0qT/EWd1d6x3/9CvlCKKIAaktJ
88Ur7EPDGCvascckrZKHCNGoeyMAbdJVWbdFs2kVKiqfZbmnUE0suiFo+/PM569QVDQU8UjU8bDO
zc0YxeOh8JruKU/D6EkLYm/j4QL9hp2L/ozzgLcRdTft0DlbdaS4EnClVtH/kXZeO3Ijy7p+IgL0
5rZMVzup1XJN6YaQRhI9mfTm6c+XvQ/O7mIRRUhnYdYMMAImKpNpIiN+Q2UGQAuMHnmEvNkvPKyr
wsCx74lrOPs011r6qyDjvzU5doddoeXmfNAU3VU29unaIqYijaSlrLVd1Ba7QUyx1Mx7otNrnLzB
7eOdIk8g2wicjWtsNZYFBwXNamqzy3cyRSczhYyqPlll1X+vEqX+hKsiIOhes8KNC2w1lsRO8L6V
ZuWL1KFEjSLSR8YljHz81Qchhr28Y3vzR9m5eCRfX7hrX08qouIKqEq24GIdaYnpzTXV0yc0gLxb
xP8Rx0uK5sZr1PkbDX4g5vUcf7kedG2IoELAAL0u4WWxqhRm13X1rD3FCOM/47uh3ud6hb8jzRa6
pv8QTHYugO9TJF2uz7ZxxRTQ3Hgq0zkRDyrymkfDVRBPjpXM2pjOlaOcagyYOCyUwFZdPDYHtxuG
NOEot63EO6TIW6k8rj39e1UNyqFDZP0vXbjk3WiRY3IEkH7wCRdHzxzlkVkqmfHkKG51gJthFFC0
3eQgZTZ2Wm04NyxpbQOrvvIJgY5RPeKCpJ2wbIJNTt0N3Wxy/sRC/8a1nWk/qJ80t1xypvm3kCnA
RDgn0vYBHAu8Qf6YN0eMy4vAmyebmmpcZ3dD0f8WDaSWNqMqzvpMjS3TpJVdQUDpbsCWIIFd7ArH
LcQYU8d6sg2hdv/1UmXvlrqj1Z1Y0wElbx1z1EOLcP+8oR+/Fprcw8FBGFA/M3s+1jizErRFEuNJ
cRTxAcRWnp4cY8rdE0C19DuvogEqcT78S95jowqEAiWFEqrsi0m2w7QtIs7wp1mx00PdOHl31OI5
eDeHbvWkdllZH/56Z5Ito2mONqjUblkMNcSxSjUaQ3+iVKx8iHE1cg5V2SfpTWrPeboxsSt9ONuR
W1IiNEBnLJtfoybgx0HJ/oD+WHjvRl5uH5y8pVRQKPM9CVp802tpsRvavL1XDCeM30dCCe+poWgf
r4/8EiCHCRiJF293yT2AgHD+lV0jC1Mo4NmHOLT51mXfGuYuLsb4Y1nP4wO3SnvXJJPAOcAeoOJb
I0KAYqx/gZWkTo2zTrlHSWBL8v4yg6KuTDFDylKx55btJK0GAOdYbf0hgP+R7uJAkFYA0HoE9UMN
WB+UTyl4ql084VK/ce+9no3nKQ2LjxespPmw65bsfJBraYQ7WcuiF7+RwQZ1H1nWI4I+zinS0vxj
URf9sdVjc2d3YX0/WEm/cdBcbj5Xh61Pn0nS5y9UlimHY5xcuOMHEpqk248xuLeRkshzq9mJt3N1
yJ5NpepbTjiX1wbrkYIsECbaWjAOzpdDIdqsTzwxfJgCo/89u157Bw+oUb4A2ecKtszQCf/6pgJV
SsWKpByfiosqpTnl2EG1kfuUh9opqlNd3zVtUsLay92P+VwFP64v+csLQz4jMWVDEJA74HV3vjnD
ozkeWvSrHUwb2vJ33/cWNVE7eBlwMv90PdTl7sI9GVAP+ZN0wWUpn0+nmYdctkVav8dDbL7rzLG4
66rSSY/ekAf3ZhYMT33UqceoTY16X6Ho+cUy2qhEDV6L/ciYyv/iVCvbjRV+8Q6CZQHe1KBTC64F
sNr5z9LroGqBudTv806vfsOXHuE30b8ob6+P/2I1SRss3pFIxkizgCVru/XiwtSCbnoPk8MdTmYR
sWPMlie61YTF73C27Zv/v4iLCQ8SuzUnxHHfd7Azmr3imtltELbNYwwG5hTH+ul6vOViknYcdH0A
FQAkZxUv7qrKbhSITHH+ThRmese1bLwrjeBJi9K/pgO+hkJYGTUa/kbp8vyjZVU+FaHI83exE9DX
MrFyBtaXlT7AWYzS3db+oSGUN+1TDXWa68NcHkcyNu0SFAUoaoPv1M5jd4016kPnZu/GkT5UjHoS
1L/c3YV2pwkkwFzjd4HG9rfrUZfL5zWqPP5YpOiwLw+jtKhMDy3d7N3UzuqDXrovmtlEgGvmxyEX
6dZmlav+zbEv+cO84V6XK41kukTng9To5Oo9Wvp+Mvb90e3CZC/UwLopo0Dxbh0rdf5U5ErvG7Oo
T2rRRslxtmvleH3Qi6m++BWLz9w3zdD0Db6Kk1E2w21miBEAaWzM9bMdx+PvYTYTZD+S2txyyFys
5f+JLGfAlv2pC+JRFuS4daWG8gKnCj9yMZnGcyNI3rllMSO8PszFBf8aDOQaLyE+L8QjOQ1vTmEr
ttSqDofIB6tbqx9VvdCV3ahhYnvgwg8fzKZ109+kiMOpEEWztW8XS+t/wnPFSzFaFEWXFDdntgRp
ZBX6QY3Foify5Gkuiupb6gGDJ6kp7I0UU+ZRy8UF84FDl36ceeF0bSiTFw6lE+LCMbjDYaZ+fgQ0
lhiHlhOElqepOOOhT9wp2bclnKY9xVul2kg91z4xbkW0xSRIh311PutzJTqtnEXoO4ip3g6GFxyM
qbEOlQ0u+voHXg8lMUE8aXlFyD9/84EVKyP+bIW+Ng7p11qXCjy6B8FGa3tn65m0FoyrhlQW/hr1
vcX5ZGjw7+0W217cQcd31PXM7EZklcAzXost/e+enK+LBzt4UMtcnbwWFrPI1TnMjVsFL1FVawBJ
UiOabgalCecjbNfBubk+k2trFSA4z1vJ/AdqeT6TetOOYSnVm6wK2czB0dNDKoT7YYqGcBcG099L
CVNpJ2eRdiKoIS4JddSywqxXhfJikhbthOcgzJf1YfHZM6Nsy55mZV+4PHA9aFCSgrbsy5g1mqAK
9osvgDOiPeOc7zXwXHfdLG6bqfc+F0bs3BipMqQ7t8TAfGNfrqwcMjMOIvnc4B+LbyloOIFRakK/
1abktumm9qGLQDtA9eFWvf4hlw8/uXAIRumZaj5IuaV/lUUJhCddp6DeUNbFeydUnF/UDIv44Lp9
dcyHpI73c6pSQOzmWS33lStxbAXwl/5QNeKvTfDkDwKICf9LdqlAZJwvrSAc8zHLNJaW0IYT5AVK
NnmEBqwY2+5eYw62EBhr35tvTTURjL1zMd95Git1E1m5b+r9n9DJ5/xATdMz9g1n360zK/FTACvm
GASGe1sbW+HXPreU85OlKl7grwn7m1Mp1HNTy+IAoycrMb5n7oA8dzSbPwoO/l/Xv/ZqKIqZkN9V
qa252La2E3aN4dWJ38WREuxVtIGKHRKwg9iNalZtvKJW7lMybNq8Gpc3baPFw83Ux2RsYQH42dwZ
9cdSWLn6wU5sMXyhbOp4+9nr+/y/QNOaU21R8Xi+PtqVQ8rlHudClZVNmr/nK0mALQ7CzE18EZoT
uAP0k//wtDM/O0Zj9Te5PUZbGOLVCZZYMdl6oGZsnIdEWY8PnCqJbxb2NO7t0XIyMjaaZU9BMmrf
rw9wLZqsSdlUVSXmexEtaMfaGOMqxY9sDHIq4VU4O0957ub6z3gYzL+/Y5AT4qWqApFCA2OxerIu
B6KjOolfmpig7QZOyeLQNuV8WzlltAXkWB/c/0aTX/fNtgh0qMpaGCe+0aJ88TxVcx08gEq2frlt
tCUvsBbs1YlLsh6prC2GZoExN3sFx+JCpEH7cUyyxN3PKLQazzqcaWvj1F3bGRKpC9uWM+cCdkVd
rVSmeop9XTH6fGcJRHn0AoDQLjeoeZ3CwfVKA5Rm3/xCeHho/2Fn0IljyUiYG8o553MraJKXoXBS
v2lq50fjTM5JS4b0WCqN8RyD/9y6ZlbnF/lMqRSICcFSMKI17S7WwSX7g1ar88FLoefv9Cjqh32u
Vpsdx9VwlNKR+QByzhV6Pr5eRH0r0Lz27ciATNrU2pzuG9XJ96071BtmRnKyFmk0hX750IbESg1n
kehNQdsUbZZkvtcNbvWgTvFsPAywJzay15XjzIOMRSMRxg8fb3GcGo4X9nVl5H6Qj3Z2o8WmlYy7
eKinG6tS5vm+dDJzS1RkNSiCs8hJ6ugYLBOvwYicqpf2lt0YFMiqjUBkdko3Ds2hLVPDvtHmutgy
sFz5fPjD0lBEXo0a+LJ/EiKQaOmVmvqKVUcIs2jUG80aPadAxHBQC+gt1w/S1VFyV73KC5F9LKZ2
0usxnJsy9a1qGr55xXg7hboh9qLS8paK8tBuPfbk3bNcNHSnYEPyRcHFLO4mDbx3MqEB4895WXw0
Z05bKqqz3e2tilP2HQ1qgOOq2jn539/KqBaj9IoQPFfjsoU6Q/py8WzIfCrJeXVjCbRanLTJjXfZ
jDf9Php1I+52oQhUd18ree9+vT7Za18XOIB8PnhS+l/++ZuDHTG6HsUQO/f1PC1/ub2nvLN7ww72
cMDH09/HQn2HB4PMQAAhnsfyFOSA46DGsTOsrMdYK4ovPI2CYJeo7Y/rodaOAakaQWeM5gLp5Hko
xWxJRRDV94sg1MZDPrVOeIQ2teVYsDZ94KkALpEcU4NaXPplbeuD2TqFH0au9ZNWsYtVZVegjFHg
sHt9TKuxJBCbmohUoFncE+hL2dh9e7mPcHh2i8BN+QG/aMdBlMHYIrCtxuL0BAZNf+PivRx2aPnB
zMz8KsVT6y5Nh+bUFhwRJxy0is/XB7a2/XTyNHJhj2W4LFxCt4+wFcXzNO0TG0MR1dq5EDOeEAs3
cZsYx9+1aYx314OujhAUCLBG8n2kp85XCID/uewyFn6dNuZj1mbdr8mq++lgtUB+D9eDrR1pvMzR
gpKSNlhunwfLJUZKU1n5SVZkzqkujHzaxVoNYEKd9RBT8QJa+s31oGsj5JFOmwgJW8m8OA/qoeWs
xCa+rq5al/Fu9ECQlsbkPojQ2UITrMaSlGl0G6gJmItYlP9sPZiD3Pesga6vDf3qWFoDPlWaEW31
39Zm81Voj6FJfZZFsNh0YtfObBQjqTvnN2j7ZDlo27o+ankdufe8if+y7SUf5jDBwWr+35CL1eKC
YRZ4vBV+3iAA8hhnRv8dD6y62ruV2n0cKno017/e6iCl1BKHMs2RJT4jqdq+GbK29G0Voy/I3eP7
QIm1ZNfjEn83aUnx6R8C8lDiEJO6ROai52PNzSw0Ly/9yIny08Dn3Nl2rO67vG4euJ7mjeNsdYBv
4i2+4mCFeWaGRekPFdceI+QjUno0f5N7Fz8yTbgbtU25yZa3PGV7qo0AUQAULs7qqWG5hE1d+o6a
1/mhtkcd6lnpVhup4dpeIEOQYuYo2fDP830nxs7rQgo4flR31bdMM5TbJszL53by/g6u+LoqJdiV
BALvHu6780hzK4kkRV/6GA0m+jEDFvGjyqLNFHDtU0mJPqlmh4HYss9ShEWSxJwffuLU4XNeVsGn
ZG66W4hsH4uqNjaSoq1wiw81AJoFoZmUfu1KS78+L7xdWWhKSf1fD8XBdpp/eHJCNqKjL1c/326R
mpA3e3Onm4Vf0/c3D07iGDd2kNfVJ6vW0y0ptbWVSE0CYTLY4dLZ5fy7RTiVpWE0lIjeW86HROli
NOMqYW1ccSsPW1Jzkkv6cZwky3feMPZp0ExW4XdI6wcPrh6p3SkTdnUSvFweWwt3jH0dRKUK10Zs
iUOvfcW30Rd3nuo0Ml1xSY1mQ30OyzRsbvJcK71diiKAevAExk7Xj7C1eZUTKrGdUnh2cYQVtY3G
T6IV/tjlyXDSFW2obope3QLqrcfh5Qc9DkHQZSOwanMK+jwVfPRXFfGfF2uD+OBR/vlL9ZPXDS7F
T1BUltqjS7fcxBmnco47dkIV58opyut7c0TJKCuc91FZBsU/XDosfpnK8gyCgXe+MGsxBwqvwNI3
x6CvdtkQlIcpzObbumo7ex9Z3hayanWNgjUAti8JnktMYFEZqagapfQVZajv3XJu9gWwqD8zbcET
u7V5xoUsuxt1br7ri2Ut67TeRF5s+botBmPIUuHPTeIelXGYbjOlyXdpU0SnGQfMF08EyuEfgoK4
lChzatvLcwbdGhFiVF76yIwh9aPUgbsTAxzghFTmoHKMd3t3MLeupNUF62BXjmMLQBNr8cAV6SBQ
YQ45cFx6JyelSx33KCFmG1ff6py+iSO/9pvXpDerVCQSm6RlqI6QR+P/cCXUpLATgs/HGO3zd2nY
to/XJ3XtwkXunPvJJv0EMXceNUYQDMCcfD/MuTKeEuTc1JvKGIXxiCCpNW0cq6vhDJQoZeWeJ8si
ceHV0HRj7aU+MiO68hOHrC59p3aWsPud7BYn364Pb+3jIZql0n+BAAEq6Xx4rTly90ZtAUcHo6qd
pmUkhFXt2VuWs2snNv0BSYCi6IoI33kgW6usEkvszHfSMv7Zlno435aw9IobAScJ5ptldLfXx7Ya
Ur78TNQAKA8uxjbrk6FOXpv72H3l0ZNnASX/05da29yHLQYV+wyhsnojv1iirl6PVUYIFgMe6qU5
KT30ylFjR8FncA6tH80MSPaGbCrXfmtmX86H3Mwy/dT1KIo+ZUOmOQhu1q1hITNnDlG3c0qoUqe6
aqL4cSLZ+3J9VtZWGO9SsM7S4Zgi+PmHaFo77Cr0dX1ThPOnAtpgv5uSbLoLc8/7dD3W2palLwRy
h69AvWSxmnn9tkVsKJnfQXesD2oUieGT3ppJsFOpxO+9NPnuunNub8RdW9VAv9hCDPASYIFqQUsW
wqbt6y7zvsITbpV4r6ljvQWyW1tjMgVCrVeyOZclrmKsWyURU+43iEsFBz0Opj84N6so5wbFd6vR
ptP1KV0bmpRVoaaBBtFFwdvJSsC6U8yiVvJ2fI7auc5OdelCbbweaG2dyM1j2BKPeoEZ4Qaz5rTg
VdqmmRHteq2Ou1tXnbrmpommwd24MVcnEmVGtiooFSCL58syFz0m8zaAsqIdx1OMGtaDO9v4e8Rt
7Dj7JBrH4F+m0iYtkEUaPDMXO6FOMS1QseTztQRPteNcBnRDTBDev6/P5OrQcAmTCR1rcllbS3OB
/G7L49dW2pj2Txdh6hqjPzrs9XaM7EMCfK3ZmE+ZYSwfpHIypY69JGEstl6eGmU6oVjmjw62JJaa
FN0usOfm4MzulO57+n+PWDkEt3mSig/UVcXP66Ne2/s8QyjG8ljlpbr4oLg1cbrTMfBV3OnjXdCq
moDq2oYQhwRwK7WxK7QpY8f+ej3w2nQD6GXg4F855ha5VzIlXJM8/n23VNQjyTrSz3bfevaBZnDz
pQHBNm8kCatjJeHCx1KKzyxzdlUIo3daJffbwhmSm9SDHHqvKKKrfyjJHKEqWLc4V+1QcUu3ktz1
2JwEEsvGibCY5yoT1iChl/5sUBEIrSR3HvA8kegcNyu+jW7UGLveAEm30Q1bOyBoKtDzh2t9SdFQ
7amxJ6Wh4p6g6oiveNqMD67NwfcRmkoSbZWo1wAsILqgMAF8YtsuKUyiQdHYTRPq7vWgfbXG6M4c
dKruajeGj5FTp9/rpI/uE9Wpv+ppET5yMeWftG6ynq+vsMsp5/6kesak0/nngjk/q7R4LJ0Z0KCv
BE11kxmK8+C2eRJBwkFCcifAlACQ98bmw/W4lyubuK+6yVw3kAMWCU0P+iLuHTfyDacXJz0zg+TI
xrXafRZ3s/zUIt3IR5d0BNIZGRPKCI1BSdFYnCPqjNmmhlYiL+02dXa9M2e3OkXR4YunGHW9o7Vk
O/dj7DXZzRSkv3gmNF6405NRbJH0Lo80fgoPAAzDaRpc0A8dB2q51Tmxn1S8bGZ4Ir/FEM/xfV7h
g3MMRntsT8pgR7wQlNzdW21qOqfrn2BlEfIjUBeAHEHJlrr7+bePKQ0UVk5D30nIYNGpLtv/CqOz
diJt7KMTo9yPayegNRbx5Mf2wL/MQtS8eaU0mzI6l9mAlLaUQidIQwIalnv0zZtI6HOLZucY+fPo
2mhAmELLb6jloeR3fdyrgSTanMY+ZfHl3isnFdySFkZ+FcFqRcs3jYebzMnqLVzNRqDltVHrtW1V
SUUgw6tuY4oUSBWjXSM2PuTaXgK1g1icRJZzoJzPnFurapq6Y+w3KTJqOypdqnoykb8abiobnjtC
gGrl3lyfRbk4zi9lVg0UTPgqUNoQrzwPWtGqVYpQj/0QyY3oAfTd+NPTsvD9WBZjdgJVEY07Y5j7
UzFVdrrxDVfXLgMhIZAcQnup86rHVqcZVYVrZN+VXx0jGh77qA2tmzGkPrTLmghR6rBM7PmYUK01
d9rYD3YB0N/VfhdCbavD9fm4vEKYDzIiQ3Ye+UsetG+Wb2uqSRB4IvGTwSq+Zupc02vB6+5o5+yj
67HWFhY65wiFUmTiSFtslagRWqPNSeq3MHDGdwig6Khx1/XobRV/1iNJPwjpenoJtIyRWWyjhlGF
pj0dBMjZ9g/eC2Krq7I2feTK1O+AFvD3xVmUZHpTOUoKuEfP3qtjVH5T+va/aZ6ccGPprA1JKgOT
w7IRqIScf6gsQOst7yxgE44+ZEeEUDukvOkLNBvIs7UzHh09fE+4cICFLK6b3AYHXyB77sdR5Ewf
vXLI4h9INsXJDrNHEb9P3agPoOCpVXfqlTZ8agc72NKtWbvg3/6KxQWvGj3uB3mV+G3bqLe9m6HB
l5M4H9qhNu+tzNIfQFZ0/caTay2sPBykpw+4wiVgI6GJa3UiSnwnGor0EIaheYc6jfoZnBUud3OH
esMjXNF5Szl9bSGhWg7mSMrTXPQM4m7Agb7SEz8GH/8AmJL8RXfwZpKS7vYWpHw1GnX01xIEcNxF
xupFE6zwYUx8pLmyYzWN3icvFhMlvDH+dH3Try0nTncwWxKfT3/pfN2WPSweS6QJNKUI7US0+EW7
g3OZJPuwCS193zgGIFyRplm8C2F97lUtMt2P13/F2oDR5JAPEp4k4PbPf0Wtdd3cwz/z3QDNob06
xpp4LvN4cHZGX2Kmez3c2tWGKjK961fm9vKW0WFktUPGFSoo9PzuLfXr0GE0kKBL+AVMd7IRbn10
/xtOnh1vDvGwMidtznNsc20jrY/YtTnes5hn4BU8buOtW2xtk7yWlCRqXOY85+HypnX1WitD38Y/
JnvMdTVoUFdE/T8+1YmnfHeCarCOkVLbYuP6Xh0pJQoAHdwfF6UzrsFphBYFXN+yh4/4DEnTEkVk
B7dAVvEfPiIkYOh2kp1wUZidBrC3NbGiShv2+IlZD5Xo1B0w/egQOaPz1w1sSbdQwW5DhUVMZHHC
K2Y8FXaqhP5smsV4iHI79A7K3IUbB/zaHJK8U06nMMF9sjjgnaEFb690id+0VfyU1HUuiy5Kmlf7
Vtc7fWNYa3uB0gvIQhC4ALYWW8/L+zzoKtL1kf4TPkizaf1QptI4uu6QfJ1HY/PuWB3gK6DR5Uom
Mz9fn0ZKMdQGJOIXedjfZH3kib2Sli0KnGjhHK6vktVgNJZlV40Lc0lkQ6k/LNE2jPxIN+r8iLRg
Oe10FD1atOHQaroebXUygVDhjSatg5ZoTbux2qCOncgfaFG8w7VAvNNAbB5A4STWPlZjcsW/j0j5
EWSTlHnn1Xs+mRrsnCnpeN+gelsgcdP+seogfS6qbjhqQx9tTOfaAN+EW95MtW0rXYl6sl/iC3Uo
5pFnHIoQR97H8Z+ZasLvfxme5MJZQLQvGpTdCK0dLyA+H4qFvwDCvbMmG4e5orOnXSCs/h+OatqD
VI1JFqXf4/l0VnYQVxqNBb+3C23aC6WaPjdpG3gnMn3j7vrg1h47bAFLctDR0VhWDnSEmIaBioWf
aZV61Kn53Qpg9g92pHrKzjWaEu1q1dvNuOD8uB567TtS/ER+GvIueeti2eD/lqkYbKX+1BrfMmVU
k50dNumDqY3YhoZq9nI93tqdRK2TieWEoda6iJemeWMVygg9w7Gr35RW2+KQl2lx7O3SuCWd9W69
oNbn4/Wwa7ufkhf/k2q2F368aJPAbHM6gJTdqN+NA4WofW1DYioSoeQbe2M1GM8M6f0M5XypltY6
ZdyEapSBUusbP8SjajhYTt8da8fsxpt/GBlYVF4CgGaAEJ8v1EyNizaxMlxhQqgSaIvmz66S0TBq
rOhfEopX/B2QGdD9S4ZjPob53KPX5Y9KV823DkY5P2wRFR+Q9LF27YRRwE7vQ32L8by6SNG3AXwh
Za6WHdFxdJyEJzEP0qSqv5ml674nkZ1Pc4ws6W1OYd3ZWC+ry/RNxMV7cXZjyx1cm/ciFu4wOAsp
j1aFzwAFzL0xzY2zQ7I3Ol3/lmvnAMJaJBWQNByqD+ffElez3u2mCdYEFbxnhH1sjB0LRTmCAsbq
bp687MbNbPVk1EkpNnbmSnCaOyC6TMOQNr6LhVS5higEb0jwckbaPDbGUILLQ7PR3ef53CDV0CHe
eOtk2CHsYiWd/iFnpGRJjVxWOJAxWDwljXmey5lb0+8iTT8IXcimj+X+mrSp3HjsrCwolIJYF2Dg
0SXXFxOtTVOTpSaZx0gGNx7IwDVxr6Rz1B80d0zS/eBRVto4FlbWFFgFmOyyFC6lt86/ro37CLZW
ZgyhotcOnldH3gFYvPOHFMh6qMMMoX9txjv2+qIy+c8uKmmyCUA7TR5/jroYqxNqXY8hlPsyNAH1
yDCt6v65hUCVbuSrq+OjnSS5+oC+ln73YNt0GzSN9wJgA+V5PK8j3G0wUQ0Obgjo5LlBqxutjxpm
kH99jGvfU+IFJacceJYr5+DNw8qM9CpXp8x7cSHvP9rCNG/6RLQPQ2YiuoU00EaytTanyAu5ktVA
lrAE8gAUq7IEpMKL1QfacKchacgJL7JhCyKxFogt8Uo0wiFxCVSyzLZQvKxzX4opHu5Q0Y/2xawM
d5ODIyI8x/SzDlcsPoV1eayzQfklvBjyQ2i3dnMLRK/+XM5OW92UnbFVglk7LygIA8VGmkbSSc/n
vMrnrhu7xn3BSclT76vMTMJb3WmH7nOS9rayqxSz+wgy0qhOplbGW4YSa99cpz0EzhBoHn3+8/gO
gkCxM2vBC1r+7qnAnvUwARXDcc+29tUczBv7aG15S3kgoODSOWOZKdW5hqkulpsvDeWon6owUO7d
DfaQDsi0w4fewSHKh4dx1uf4+fryXlsF0pVb7i048Es+ejChp6BqufISOGbV7A2l6vojoqTNf/8Q
h6efdHqDHWEZ51MaGCjWOZHuvRhzPN6mooaoa+Zs943ts5IggTRCtYDOpFTKWcQpI23WSkvxXtoG
yDkIzvyBJ3dzQ639L5UjZVOOUFJxAvAmlSX5U96cDEXeKqjwEcqg+nvb5+rPNKiHL6Jp1I3jb3VQ
kOXokeAuAdDlPJLe5XaiV3HwksdRe0gLfJhr0auPrOFgo0C/FsqS1XnJ5qSztggFGagHCcTW02J7
3k15k08HJxZFBEPNGz5dXxRr657kWAqcYcl30Q0oshHEvh4qL3aE/8khVoc53jmin4s9hp/lnTdb
Kmp4xlx+uR5YJhzLiwsoKtVd9MZMODvnE4qHJ++6Ng79uHbqH+wP8Slz1J8C8tWjlkTBKQ5ssMtj
LKrHNm3rm+vhV8btIh+tkW7SyqM8cR5ewbFFtGFPCSv3ik9AUsdpj9CFeNCtPvtuV178CfRhuyW0
sXKsYf/FxULrBarnUpc9rcg8QjdFIABRyW95V6UgURsr2NlKan4ka0g2DpfVgCxZeYRT/V2u2zZw
ql5YKBJEOLp8reYo+DA24Sct71KNiwSXtOvzenmYSag904qqAxGXWMMqs9y67FX3ZXKL5GOgmdxX
JGF/KYVFCi216kwqyYhIyMfY+eczEjUvFCsSfmPX2Scsql38zkdH0IyZjPYBV1k33jW5ZW0M72LZ
LOLKP39z4PDCRtMgBLudhRaXQuBYz+4wlKdcKYZj4sRqh0hAcHd9Ti++oQwq68qUt2BILWt32cjC
jExD+D1f8zBD3D+kNdpEdPj1j57oyr8964gnq6284EEPXahIaIPa0PYPhW9bkdXfVq4w1F0LMVJ5
igMa+zfXh7c2p1x+kgUpsYpLJEEaxyU9lrTyLWhChxTKxgEGXXGb1lZ9QhzY3pvgiDb2xWVQtj+q
DpzP1O/gBZ9/SOrXWE1bY+m7tNRAvnsPaRA30c4e8mRPx0uB67bJm7842Q2CaiAkwRFy2i49SQD6
11GuO6WPdpHqHCJLaz9mU6JOh6rdfAWtBqPoxKeU3hPL7kcqsDzEi1n4FfnOV4Cn4tkRIAgxmlW3
BPkvdr0c2JtYi2ytj9160KdC+BktrfGIfBtm0XY6Ynxwfa1cbgUCoYZNs4zzk7v4/LPps0hqnLOF
76C99DykXXEDhTzdB06o3yej222k6GvLBIlYyndI0pGeyUl+s99HboM6NALAn2DU71oWx52BZfew
ExmvOqdslOcqbo/XB3mRezObb4MuDjdKhYVXSWpWXpfzIytD6fYYu/Tp0Z3q4mtXZeHPCJfKXY8h
2I/rsddWDf0yANsU0imlLybYKJA7BboHicEomnmHmAyWRb3i2IcUevDL9WBry4buFUYSvLIobi8G
GrgZQL4E+iVktOo5HZVJKv4WRXi4Hmd1QiVzAcichLosNjuSI44ClQ5o4JSUey/32l3ozb9rNfgJ
gk2d9l1pRZgdiCLbOLrlf/ksy5Gf8v9F9pa6/NXc62HQwUmuWa9fhcQmoWWs3uhdKG6zDmWt2RCj
2BUYjGHGo3XK5+tDX9swGn10ydei87OsyJrd4AkRG5CNButB14X5Xq/d5qgjbcOFqRffr4db2S9g
MNCQ5UyluL4sMwmPQ5u9X/hBabY7oY453jNujf+7rqWfHbV2H4cE05DrUVcGCbGJF8ArreKigpi6
oi28DhbcMLTOQ6yWwUmL1OI+GGs9wnrFnv+a64PpMxcxxhLQKehtLQ68Sgx1IzNH1HMweB6jWq9u
67bJ2r++is/jLM4f2N3FWEBD9vFiC/q9anT1qe963dmlLcWP69O4slh5bPPd+BgonyxzxS6PSQji
Egy/ISpt30Oxxauxbv7DsixEpCBBGmPXkPPhB5jWjfsxoaPgna7/iNVvSQdIwl4kX2Lx+qm7Sotx
huVbFsFEaSmdT2EbuLckJJSEW5C81+OtHHhg0LCWpueLXMVSMqvTlKoZevDhItWro9Jyyu2azNNv
59krio30cXVwaM4BmlSl5LjcPm+uE92q2sAKoIjNmCjuJ5RePqp9pd4hxqa9T6cs3NiOq4PjhYUq
gqT+LfXINCcc02FmcGXa149jZ+JzIAC5FODNR8/Y2IZrmx8jL8qDNA/orcnRvxmdLXSnzpq49Nkd
4y5JkKadA0d91tyu+8ClPh8Do3H+/P33M0HxOUidcL4uq+qhrRapHU3sEFNz33lCUwEOJtZ3bMiH
jcN87eu9iijbdH7QfFiMTyuNpBqmCHR7mxTjY24ksXJfjp02vSNHHoPvaqeYSrKxZlZnFZAzAEGK
kfz/fFatsqZcXaH6kAhV/dzGOZzNVh3Tn1qlu5+rIH1XqpGjbERduTLB01JboQghibGLleq0aFrU
RpP7oEriL14y4abe6cI9uEOsZfugsLxoF02uXt5GSp5uqWetDloiQxE/RxbJXqYhdVYGmqLmfpaV
2Q4gFsQbwPzuTmlr7YgYOkzVrDfERull7QuDT2KSOQg4exbHOnQ2HHKiiMNgqPM7xA/nPXekuE0q
3dqH8KE30tm1YUozCxDlHHe8Y8+/rZcJo4gEFA1b07NvCkaFhxqNzQ+z2vZ3Vtur4z6FjL+BBfk/
nJ3HbtxK166viABzmJId1GpZtrVlW9KEkLS3mVlMxXT156H/wXFTggh9AwMGDLi6ihVWeMN73xaN
dzgSZJMoWa8W11XU0JCIezyMeBIG4VQqO8Kg6JemtuNhHKSyl4bZvYLd3FJ3fne+oKfZUYtR61p0
rsRbJg8xYnqo+8750pZaF0QpsFC/qqpphxtRtYOd2Gx0+99517hd8GJaRoUDuX5SerWmghsxX4K9
K9Cqw90ApnBXTkg67JK2sgc/KyXPWozw3V3c9FuGQcu+WYWBC86H6JNPDQpn9QvmrNfUEEHXh1Kf
3fQ66aFh0j9xP90uBtIMtJdIj64FZNZVUU1PY7NBmZD+e+S4TSDzScpTMzeZ2CeNKLOrT9+9bKPF
DQ6eGuCN1falBqNTjrcRLLRcdpIQXazf2KEZzgiYinzOtqpL7+zciwGXf//rhZmH2SZfpnEruWl3
recooy8Vr/1VNSSBTd+KK0wzypesHubP4tCWpeWY0mNbiDfrpxuqup5lDsqTRtS5i+WEdLNDOevy
Z+0N3r9ZWlgvH6/uO4eFEbG+AClJK3N9BdOgHjuzNbOHpm7iryq6dCYi7yJ/TqhM/C6VHqS6sDcN
hN47LX8Pu1pj2WPFrQFEe/Ci5llUwjmXZpdlvi36+rkKm7Pryq9W18rrUk1Evf940u/cwMsZpaNJ
FGoSKF1+4RaT7lDv+MIzvrhw9opzXUTTc6ea0xENsOHz8TXpwqIHyaj8bbWD9WlAunTIkE2U3Quy
NRMhSqQ9QPWBhvzxzN7duzT5uINAwGJwczkzsK9h6S24ETA512FdFddGE47Sb5VIHiF3dtDi4tC9
RgHpk+5MVEvZu38NvfqkHjKUydDW+YMGMQyMaO05e08xrV+wgceNFX1v1y60b3jmFpHgGhuHdSC9
/8xEMrWQfRuks97117h59e2hURw8sBS9Dv2+1qz56uMFfifYXUrPC5fbhHSwLj2XMvJwlkasFerD
dB4tnFLcZrJeTdnKjTjh3aGIAckC2TugKi6/ZRjrodRiRG9BOzUnt57bE4pRzve8Hfu7/2FWtFGZ
EohbXrDLoRQxWRkkwgwKVZEeMRVGZCyT5m2Cp9fGp3t3VhhdAYmj8kP553IoZ2bjIlnChTPXfe/3
2WQe7NiU/SHOHTF+PsLk5P3/0VaxFniiUXVT4EY6bL3Wl5Vm2V+0cDCDJM88v3bGIvS1VneOldWW
GyHQWzofRwKROMy84KqyX1bLOnv4P0b4Oz3A5tB0H6JB3u5afaFRuog4Oj4+NPoNZTjrnyJpbTWY
naK9xlU336KUvLfqcK+48izInKjIXa66Xkt0xuq0eCiGdjj0ICDPNOabvW1lyhbE692xULAnR1tI
B+tkyc66yqk1dAgwXUj9pJCpFlRJa6Cj3NF6/njnvrfG4HD+WDgh3EgD43JmudVWylSK9IG+aTf5
paFlw35SZ7nv80aaR/zB5RBARrKna63TxK1nx0q1K/iN3z/+Ke9cSuSH3L0OmF1e1NXdG3nQ5tsc
JlIicuemTAbDCxzsKK3wNSzQbfHRj97a3++8ZDS/0fKyYYhhaLa6dOmE2fNUGRD4MGd7sVqt0Q5O
UyTOIwLzOHC6iVt+WrsWvA2+zy5ZKgeVV/xyxTtdQLubYQ25skyvw3nE+NT0hvEKBqd6G/XIV2+8
au/NcklNUXQFoQjJ63JEKw/VGOub9EGZMALrdcU9tQpGZjiWuYGdoua3MeA7oTTpKB+SEAF/w3W9
xsDMVXV6Bky11A5kp49in2mDtiUN+N6WQfSNBJikmwdttXlbLbLHSHNZSvCz3/W0repTIcwhOg+0
OKNjXSH15Ydj74z7T25WTgytqQW/RpkIVMPlkiYJaAldiwDOD1ig+fBW7DgQkVHlQe4iaRZY+pQ3
geWVzr+fHZl9w7NGpwOuEOiKy5GjRd8c8W/5EGm0xwNHSzNJZ9qOZz9JbFzYtXLuDlOvbV0Vb+4l
NuxSNQKUwmNKdeVy4LR03USMxQC8vWu+CNFfR7KbTX8SxfDZktgSVIJOWdzRNZqNqw2Lh1sTtl7s
PGRmO/3CbGe8S6IwDrx+2lIwezsrhqIlzI0DwIFTcjmruhnw6dNS50HS+hyQGgcPAGXQGs8FPlW7
j7/dm4O4TOuPzQu1Ig/c1OVgVQpZfEZX6NF143gPqWv+bQ729CvG2v7Hss+24tk3B2SZHIZb4K2p
SiHzczkgWnZ523RZ+ThgJLE3m7aJ/bnwinPuVfMTsl/jqUwz73+YJnk8sLSFvvsGXxCGnV2OXlM8
1l5jY62uKqqPLEOOQ4pdXFVt2mn/04jwOReEDPTfVU5dcRJTmuH5Y1HNgz+O0v1SODL6Ek8pmk0C
G6GPP+SbPIF1JW52MTjg/MNCulzXycAtQhnd4nG0ZbifZKLsofuPP+i2yEMTR3CtimxMSRy80Nt4
sk3+77/qFAuqYmmj0HMgNsCQd/V+FGUa6y4T+6fSGn8u56Db0qJac68XvQp96TEs5Nkl4lkOzV8p
fG1NirRbQ3vWxno6iKbqHin1PekT5mIjSe5jNbbKAePm7gd1h/Ymle134FDd/cer/Ecj4u+pcs9g
/bk0cRaAI/ft5e8oRQdSRJ3rJ0vPbaXyUWca+3NkxBLvGekJ0B1its1kb9FKmg4oNEVG6zthmw5f
5xz58qtIukK+dl2no2XVee5PJ7SbFycD2JUtYJSxPymJAMgAttXrb5vBhoSoWNYvqXRq62tm0d8a
FTYBrxtTW+6Vy6mBowcZY6Caz1W3vnc6uxuqJNSSp3EA7nwL0qF7QnrdGn3CXmgok6NG+6xLXesq
MWrT2Nc2XijGvkzKfD5PaqVp35wEyzd/jp0h3k1lGuG+WSRzdYQzloW3GpBqcUojih4nY3TS8FQV
eqF9zzL+0bF7w9rQWFndbrz1ACc48Eg98fhjDHf5tWYAfaHj1NMzUGNxp0sPvXZPyxy4cl50sMst
ghDhz3oR0VcBOAHUjwIpweP6Pk2GEhdloTxZeVJZR6WdSMRwFEeP4FpTBt28cQDEaF8a6bY7zy69
aW9h31H6S52mODRp5D6h86VoOOtMSCUD/OrdoE5gVBxSJW7Ku6LN1AwFiTn6aknTsW9wDzQcgDbe
UB5jt9bKX62Jn8vZNCND1F9r0U5q96UrpuJoGnRX7ubUG8RVJmRh0bxOlarwG7MZ+yN9mOYaqSPU
lJp81JJvsxYNX0q70V3fgXT4YiOqNgXCbOZ7s0ShY9cqPacRIYv6kE7T2F91hZKFR5H2ehuMeSRu
RJ7XaXqQlTfK69GdG2pvgzGF9q2Av/yaURDrfUcPm3rvGEqZPE/mlLh+m+UIu+VFZkX+qOWKmR5s
JC+Tf5CIyh+9iSU7l7TInaC2ijz9UtWV0CVlApOmvN9ZtaWcjTp0npAUwY3cqL38Kx7ksvOnEKPJ
o1VEKarz3pSbp9FNtGrX6SAm91BZhmrvsqU7v8tH767MWx2NnMFqvSMYvSz0Jwu14GCMWqPBy8uY
uoOTRTI5NQoVmjROZ+Wu5RkLr8SoJwVCK/MY33v1ULn7UrNjd9dKcK03papWmAqFduH1+0jLVOg5
jjk6594UmkPboA3LACeH1PTnaXR/GhRI7bMz6V59T95kyltLWKVJ93/OrnVpGuU/VcxpvcF+d7xV
rUZKP7fixPOLem6iU93ro8fT19TW3jSEVhwV6TnpFzXTM/u2gt0Mrldp5vmqTVxsajs3Br9ezKW4
6s1ROSeSVlzQq+lQPkVVHGFsywP/gl6NMwW1LapvXJzLqiEeNe5NocfT2eiaPL91xDD/i/5NLE/h
H3s8PxWGZmQ+LLPQwaywx1Yv4LWyp2MUh2NxOw+qouW+kXGtVjuliOPoi0lIEt6jNabJU11HnvbF
VBulPIUFCi4iQL2pLO6jolCiw9jXY/ys9Takx1Z1UOretV0e6vsh1CtZ+U6B9uRP5MpkrPuD1jpC
D4ohKax/VECH9rkQgKtOTi0iQbuIvCHg6MnuXnUVvYwO+mwYVRQMieL0/lDYZng9DPZYcWqSKGui
wO4xU+r8vHYT71cT6lm80+0ppKbe1rQ5pzhSf8QRzokzbcHIb3rwgaeES1k7dIWq/xe6XgPZLoqN
3WBkU7/X+0Y17udYmYZnzagMgCi9KtMfQ9Vbt6ZixPWNJXmVfO4mnfa3G6nNNSJW3hjA0u+aXe/Z
wHIGXRTqXVoX6X8SkKt1q6pkRBM1PdsflbSYA5Gm1nHW3Fjz1caxX+y5NH7VaZNqbO9Ya3b2NMNV
DSvkWeFuO23rixxn9UDHUSml+tIKhBZgiR1yE902oEZzogXtNMtXV0OXN2gzpfjWAll0/dgW7niF
BHA9+X0bhaNvOaUorutsrNuDGnfxaTZyQ9s1XTcpvjd1EzbbFF7RcyecEsUuGgb3K46iSu23JpTM
nRlaIj4aJppl2T62csU+NLNaZ6cezlILCiHPPesRsx/MtHqTc50jGBrv7Mbrza9uUuGbljd6aN5U
rZ32xSFVZ9O+TtBh/mXl6dTu8tmw4oPVIEcdOHVk3SOhmg4QvSend31rsHoR+bVLBh3oaSa+RiYu
SQ+5B2YJEbMey+eoVpfZiapXdnT19erA+w+1EbEBL/8uer2/UodSJ11rYJEExRgX8xm1+VB+ndu4
2os8zNQHvC2M3zxsZvQjKqfpMGptqb52sG31wGpnQF5WHOXt0arm8pvqZZ4VCLtJrb0xmrI6TDSb
+qCya3M8KLQ1wW5npV35Uwbm8SqnPxLvytB0fpWgO6bz0Lk9LP3cMuVJdt7CfROJ8Ie568qbJgPt
ta/sZLRPpTawn7VC6GihOqpo7sykRHsIFFNv70O1BI3eVg5W4D1GJrq2a5Ga116mQubJrarUs1P6
Fp5S+k20lFDBAUSsp8ebIYOQPKb6JdOhEsnRASupOLu8iuctB4NVgkI9AnGwpUTLA74wKFZ5NMUn
VZlH1X6skuR3OpjirJoCV6QClO2O6Kz7mRPxf65N9H+DYiWA4CkKMW+S917jHVJxsn7sx0G9MtVY
54mf5/GOfMb0kVqPtrCXq37N/41IH3epEcOeXFt8IjiMUSSE4seyaedmX07NfLbtAbJm5mjhLe24
LguM1MJ4CvinCNTGmDaqqfo6b6CEirPO0jUCQWOi7ngZnuG36Vo0btLnKO6UuxSyUPeFq1WIHa4p
hbuzIiqcx9LqLQ+ztnyu9zUiSv2+iVAU9jMjBXIP2ao+haDV701gsj31z87rf4dD7Apz12i5TH4O
SqyqBwgYhXpKvKb9ty5tO+dacQtxnkH/9VeEQuUnpfIJPukPURKnefvHt2G1kfp0tNsqnazn2dDJ
i3jstOhbpsfNeVD6JvEp4Ypmowi0qh38GRNLCnqNKFgvANTLFW1k6U46ldDn5VKXCNd7Q3ItFWoK
vvAiKTcSv/UmogquUhmlwA/NjmtzlZUBMQmlN0H4TSOr7a9E1OX3da1F8mtohLyHLiGX5hOZ2eNB
dJ1R+UUpXbmR+r6ZNJAL1Sa6B28LOXwtk2t0PUKDsa09h0aesK5e/aB1Xobxnp3/93GS9CahYCgq
XPSJ2LjUnZYd/Vcayo2RxlFX6c9EEOVDO3XR2YmT5qlDHaM/VpqTxYePR1zl9SAQEPlA6wM9paXa
tS6uZWncZ6R/8YuXm7HlK0413Gp9od1gPcwLWNVoLIjKIErutGrj875dWPwLwfMvyTebeQ1DLa2B
/mmjpC8dJnF1kE128lhQuN3ZGI9uZNZ/VB//Tj85Z5Sflt4KTGPPWdcvo2EuizlO1Ocx9abxUFVa
Kb+NSjvMZ4tkcdhbmNPBnOIisHalnrtPIGB6PaABBiNtgt4+5n4Kazb/J64N6iGLCNzc3OpVKbWr
fIps726ux65K/FQhti79yjDi6r9kqkKLRKiHATL6QoZq8qMiZoj2YTa3xa3n5kUR6MBDsz0CK9qj
GqMY6ttmXYNPrehUkkhWaXstiniO782msppvUakLWfqzMUqxA0mvRoGC3biCUZgxhOmpMAHu+iIJ
dUk+EerKHmdgK+2Dzu4156CDhZjTYDRbp619thpNiH3RW/0odlKgkjqdw7TqW/zQCBZ+eWFUlC9O
3FjtJ+uD7PSFjEkKvdhZUh9cbfhEVinGecP0SE8m2idzqfhhnEC1n40XxMWUjV7i+kLh8UW/hg4O
1WkQDGtJtq6JR22IO/VREWRlB3vKosOkZPo3Nbfy6Ki6c7/T3dxI/Sw26shvbZGZ+49P3PqM8xtQ
MuCAU2aipemsKndDpCpR7pX6Y2RHRoCeQXZfIjfo0yUxCe6gC/ofD/imuPVnRN4IIDHAx6i+XN4q
WaVJRBtb/dExid+SziVzi5vkMAgM2FDknI9tJLSgTLqfSqKkZ02aEeZGubZx17wzc1ae92OxcwYU
vZp5YcUFb0VuPIZdkpxU2G17s2+m74Db1LPs5HC1MfF1yYmJL0RhrjfUVEBFr3ZXMzlysAbbfJxS
r/3X6XL71iPDtM9QlhzVT2Tqeruuy+b8KEgJKSY0SrOXel/Nu3AAA3gAzxJuFI3eCQBd8IsaXBFq
4ggfXX6NSAFZAZ3QfARqFQd6WVp7V9RoR819OTwVYpydw9wYofprYzXWtaNlNegSQ2nizrUBiF8O
3GYTGEJuxsc4dsOf4HgWJySzra7quDO8fSziad5lYRrjdC+aX3So0z3kZnVLKPadbQBrhagQv7CF
uLpaANNLRGoNo/Uo2979lja6E4RebHeE2zXSiJorMnn8eO7rV46p8/3Ze4uiKIuw2nnSqDvsW4l/
VXQAjh2wj2viDhGMJFk7lEY1v0iMcjeNVrmxB/9IIl68OwwNYhRsFshV9JiX1fjrSZcGBbYsjNzH
ZAxREEpLYrq7ODctcCCZpcv9WI5ZcwvJ2wgmW7rGvieDH4J00OJbgQxmfMLQRrnq7VDOvxtufpn4
Kv2G5NC2jja+jubQydQvu1i7myFWuEEFjesGUlBbffrqovZIk2qxJQNRvZZ1qBshFUfkLGPFw5Ja
skv9eDRzcBJelt1qYIk2QoS3FzYjAmuj1enSfVhrKtuRGWqY8lmP/QDdaDaVDh2Ybjp0cVFce7mu
XbW4SBwrLtxjzvW+QbRatuLlx+PrcYcgugYbmNDh8uOpAuQ9ubH96PWxPOqu6HYRdmyHKB7njcvx
nVuaK4E3yUZEGeTiusMSV+Y8hWNlP9pDg9yhtOR46jwNJU9R22a3Q6Ylp4oltS+OJ0rvqiPz2ut0
tADcJZWINo7Mchusps7S8zwBokSqab1vkZ0y+3zS7Md60vvvsR3W+7ia8gMyn5o/wyk94nK75eL0
znr/WXDoSY7joHV5ud6jq8C7rDr7kcDFOdpCHV5SdHgo8cDc+VzLlQyV9QZ/C61ER/V/nR1SIjba
Js3sR03o6c9hSsGC6FN6alFr3/i2b6+fZSwkNZZ3COT4KlWrPQBZCl/+MUfp3kd5E0xCpDfBlIlT
YkVKEM0SYWgrSjb27/sD43QEZB5G23qOsUFNyOwt+1EZWm83Jn155XiF45elN0K5EPt+aJ5DSys2
Uu8/kPTL3YOcDoOSVBDpmMZqxlYvE8vESOHJHNEouQdZ7Gm+gU4iTV+p5r6w6PMcpsIYzENdmLWz
Y29l2m4xpS/OZqx1bPgBuexj2xvp3lC63ti4Wt45cHQTiTsX9CxU5nXPLxEYJ4tiNJ7iqnsKwzw7
WH0aBwb+L7ssshDaoNwfmHgj+nU05kE7Rt4xpXS3+/hxervpcXoBf4lpIFIHaOtebvouUVuJA7f7
iA9vDOSoH7+1da88T7jhfb76BPYRnQhKByZ9/TWYDmg5gvDkBY8ZHYhzqBnNKYytFLi9qvyctS7z
2xHZ+I8nuJzay81An4iTRj5LV5560OUE0zly8tnuk6dGN2he0H5/lCFWx4T6ptxVjRz//fyAuEGh
K0kPlQx3tfuouwxxhHr1U99a0y+gu+3ea3T1CJVhepCd+vLxcH9CtvUEiS8gpRDRLc3qywnCunUq
6Th4ZyRuZf8jigx7SWoErXrOYzXxlYrSqJLr/7ZjHJ4bo4jpEzmddqyIxFChazMwlEMi84M1dGn/
UEFy3ViSt9c5dVaAJRAckPUkHrr8iZM3TkYStu5j2JjVTljU4NKxy8nws+HVLKTrN3HKA/Pxyryz
tfHBgVlGxAvZa02MVnD9mo3JZlTUXQAqZfrN7I3Wg6qk7Zau99u7jr1FbAd9xAR1sGZxKEiX5bEx
p0+qk6RB3Yr+iH1p7pcElYuqobybNFkFUQad5LOzZDQoFLChsLh+QzioujhsBxnnT4iJOYYPPqkM
BqzkVD8rzC0RzHc2G6OBowOUCTkZ58rLL6mUqSOnoc2eBMwfPSi7esQg3SyL+puSOmW3NzthTbso
R+drn2eD6zxD0h6/VvRgQ9/SQ/W3ilm1c56qvp72ce656X3WtezTTy4LET6oagcBTYpnvICXPzRB
Vc/pwi5+SSYenUDIJt8RJU/h3g27LeTEm6+/RCqLJzAtKMAFa1zjnBWNNaRe/FLoYXbT21l+dIuC
DjnLg2+uYvxo7OTGaPstR7E3l9tSvCCtJT5FmAouxuUsY5wBioJy03PK+/BM4Wg+9301fq/yenyG
FOJsHKn3x1vkx8lldBQRL8ejOGMIc8z057Atyis995RfPQZG+xKpvNqPNDXfqJm8NyAZDBqBNGd4
KlcTdMJ8SJJwNJ+BYLjPcz/a38qc7pjaJuXO6M1y4znU3mTtXE82RDfYmkvWtvb0mzUV91xLV17d
opH2Tgx1R8ajx7TAQy8pzwYGHv1Lrk2OpZxiqM7iDix01/1TGlMdHfoaxo92LDM9Db99vKOJx1nd
i5t+Yf/CkuARdbS3cU2rRmnTjUX/CiogVuyd7rV4QlSgeBMnGMbStcIbl4rCMVLcfP5qNlS4aQu2
JHdKasXebRXpxQ75mdLZjZpVDLddJRGFKR1Tba8a/InK06hESAzlUKzVa5olmnU1t4mZXDWTpvaH
Qe0L5aELJcBHymdGvndlF78axAqxT+xMdD70WlLeZXnRAtGE+1li0mFXRlPXfknn+Af9W2V6wFfQ
eTQsEuMvmpmYj8TLaf46m30k96lX5nEAYCF/ibvOSfyqdNxfSuXF7dGL6ojuUT9O8bdab+hadRWS
7XlgqSQj6O7RBR1O2F1ayZ2TpvIu7GCUXCllWPwDZARFA2VBMO2m1KENqGRjdZ70Tr+fvbbTnqZi
9hpfoNmafu3pcZxt1CATf6ajmO/tbLALLKJGVT25I/7Ng48qpjLsWttIbzzIru61GbkGLn2R0nT7
Im+yHMHlyutOtILi+r+2oJ4RtLXWUGWedXGXwkQ2adInWX7jTqgH8fm88IflSLwPW01Mtm/ZmYlw
0BAru0RACjhi4KnchEUxegEi8aK5t+spVoe9NOsKVVkbZ18nvsL1NnYPI2D2h1lJVfM1i/t0OGDm
KsaDVyvGbzMJZ1FAYXI9yrj2ABjqkzZx6NdQ3ce7g7LOEoyvJYVVXK5mLibvheQ68c2x7e8tERX/
gVOwPqki9WcsbnrqK7Qq0V1ZLpK/Kh36ZIZTog/hiyrEfJW2c3fdJrUa8OKA4OgbsXETvrnylwLS
AmMndoeNuy6kaV6kJkWlTq+Lf9sxzgd5SMwuOiwVA7+hLbhT6qTeqcmQbaQ3b0Z2oL4BDaZHTDmJ
J+5ypsJG8KCYevNfe1CLBtkM2FI7cIHad5qD4kcD8ggvIeqNwjt2cYQezMbT+qYsQlCF1Az6WaAh
F/rf5Q+YijGxiqKMfncoD0bfDbdzH5RBmwkyi+YrTPo0Pc912OzTWBY/eHmnjUv6TTgJepi6CJuL
rJJO+hL4/fWt6ZVqJUlZ9kLqoh0TtzCjXVVOJV5minOr4CmNwVPrVVtQ0PVjRNOc2iHJBOnEklCs
YorcrbuxalT7ZVIAX9TzVJ8q3a2OOZqq6D7W9lZUaTKRvy982o5oaSA+QacMVPHaokLm0eyGDgcI
HTpnBh/V576yxB8bbOA/AfjlQIsWAhBX1G2wc1yTcXM3yfPEEx6NOCv+7vRe/zV0oR/36tCd8Hei
MhpW1AyKpjJPRl09612lXG28b8vyvfkRsLmIo/i69DsvP2vTaxXNutx7KWqpNzscCXF4JML7EXf9
dD1MrrmP7TR7HcYo/E+P5+FrbpVq4VuF6h4+/i3rM7bcXIuGCUtO7Q3w7+VPyUupjnPXey+V50r7
5PV92fi9nF0AGwP6NTtDq2eaYiL9rskp+v7x6G8/++Xoq4VAgsu0JEKfL/VQJju7dacoMGJE5Dbu
sLf7mXEwJVyMHahBrGlWk6GPg9e1LHiuZ/+YHmwce+6sI0/jcLYTb95oPrw3HtgVmM/YowHGXZ1b
0bv25HmT+zIOloGO6+juvGkagl7xzKeubpKN+a0TwOUrLnL2lsELBDB+Wee/7ol+wfCOReS95FFj
fdPHJnosY3c8zWaab9HI3psb/V1KDQvNiOjxcqysISJs9ISx4t4Zj0La+VkYiTv7Sq545bHMLePH
p7cJYAhtcXqlfQkD73JIUysHV0lF+KKEmoyClp5KdFAznvKNC/+d08BAy0ejf0b7cJX0VSjYTyYW
7S+tWolAlKEH7KNS9nYiwyu9mfKgFmFzn6ZNe/x4iu98wSXLgLgPyWDxCricot4hvWnWjfeiGUPs
HWcVky4fRsK8V0fgdxsv6/pdYb8gREkCj3wiWl9rPrud6J2CkZ3ykpuK2S4F2Sn3W92OX8NKyXlp
u8KPDC98+HiS72wdIhakH6iMsUvf1J1j06bCbLG8YRMhMSH6K1LF8aSM8BysTH5SXH4JlWg/L5QY
UjjGXN73v44FuLAm19RJeVm69tcKfJxdL+BP7RU3SW9MVmGrCfzeZ1wUsIgVFnLMH6zUXyPSdkq9
EPGSlwi1zWgHnzYMFN1Oy6CM8Xv+eDnfuT0Zi0yJo7+03lbxUW4NcVthBPZSmpXUaW+aQGa0cf6k
5/yfZeRtJt+np8x2WZ14r29qI5ud8MUpInma9WHaZ3mWXNNNDW+ces5PzTSHG4/ke1sUWfMl+YOB
B5Lg8tuNIhRe1sroVSFTCMy8GfZ5WNpXcazVV7KS5pdKT9KNU/h2UJTSKGZiDskjwW16OegQ9jg8
qnb0ipsMxNgCOXc6RNDRDu4Y1Tel3niVD//b3H32SzLuEs5T14IAZK/GpWLdjFHscCayzmj8mg9B
SELJ6PfH47zdnlygPBUsJygQ+rSX87NlahetkPHrODjejTEVk58Ojn1n6oq3//xQC38CFALxMz/4
cqgiSrJUlXHCUENxMyl6eh8XPdhmRCw+fa2AMllkoAze3AXscTlUhJdLC6GDWWFL+qVQWuU0ThpH
oY9vMP4Vh49n9s4mQZWDx4E7dJGxWX0sM6ycQiYwd1q1tXaJM3YPuMDmp8JLE0CBho72rNiSZF/+
08uQcZG7RiGc1gVlvvUcQV00pVmK5FVVh+FoUHTZGWZh+MmUGbdUmDsYhqP+E+jBuPcy1d64at7b
OIQWSyls4W2tVfhxzJmc2lCSV6pz/YlnMg1Mp8zvnLlPTh8v79tHgguHSjai6JwFduvl17SE21uz
XRev7Zgb9V4tEpF9cxHL139Qoeq+RxV06y3JqfcGpRbGQSPhIrRZfdMC7zsg7EK8agP0XjUS3nfq
QsbNNJbxFfIa48bt9s545NIkl5ZOFIUY7eUkS8+eG0A54tVoHMsHnpmgKjq03W6YBvN3Spl448V/
+wGXV5CGFIU+iprreiZwlbSM5Ji/qpM+H1wROT/6xLAg4Pez/unNAr0OsWK6ESAPqRZfTo4wQsTD
UGWvSkin4H7KGlLk0AsL5SSgC9x/vF/ezGzJ4+C9L5JWC9pntZToS0bVYCTd6yLw9NSheuRrBKg8
vorR/w9jkZmBkFjKARTDLmcGpqmy1TmRr4YqLFACCFrteRMheLRKstWCeHPPUFGiNrtkZsyMPPFy
sB4zuqYO9fEVD+32xggTO0B60vo69ump99J9opdbRtfL77+4ZcBwgXYGNaVzDLw1TlBUbljmUaq/
qplK+NI55WJaRa1wI+97+80WOh9mzXTqqdIZy/H4K0zysr7tydP0144eBbxa3EWu4zHs8fBWva0o
cFmny0ktKTZ2zWgK8RoZq5dIay04L9LL/80taQDJK60fMELTYB5zB1hiUuL6E3r7KNPLfz/emm+q
DQiEIq6w6FujPKu+idCM0TYK2fTNb0qm9nOCxNmZzGq6q1PYRnkTDf9WyAbep6Y2Xptm6v7Ui2nY
WOs/Ws9/z59728F006SQTlzDn8vFTvDkCsVsdf/hbI5+3mwv9uxWIqOa2tEkETZJVFSPkPk3fyhm
EcOPmAztqhisJqNmXOjPXQa8/5SrmlAPGyu03nEL7JznDIlasmSkK1Y/zkiQDumwkv0PmSLjrjdD
41kBafVAxbspglyDzjZSCt3XZKLnOi17J/AsRVs4jWIJJsz+ZzNn4y+Q5XJLi+FNi2T5ccAaMQlY
wgpArZcrpzVuDip91v9Tmw6rPzpPD5ql5LWvt67xdYAjOPheh6CSP1CuL3y6E3G865tquOrMGPJs
bNaxtfE910/H/2PuzLrayLJt/VfuqPfgRN/ccU49hCSEwA3GNuB8iWFjHH3fx6+/3xY4C4U4qFy6
D1JW1ahMnGztbu3VzDWn+FIEwngCRDWiT3v3S1kdfmIXm8rjNCbDo1Eq+S8jIfOos2s30JSZqwNb
JLZg9/xwQcnjQtIMOQXMCbsDDjQWpYEyWI9RXsnoUPRZAx+ilTZuGdT+x7wuMvmdFYyyqydRay9z
nuobL9M7l/7A9Gc24s+cB2qD/Pvb32x/JUiPimCdAAik8TwusZMcRolW8X7GLXqWselR7s+6/p1n
wdqYRtXj28PN7THZUGrrdOVz1AhI5ol3z2lrej1U/9HnEXAnGXWYWiqlq6qom02vZd2l3tvBgdWf
G6/toKh2kQUHTUp2dHfxaZcL6DFj0Hyie6nRAn1NycuhITBXrlsYT9cD7DKb2qej9+3pvrK62Ghy
vySDBYR2tu39FJSG0Ur+IwxF/beisfNlEIXaFTp38XKwg4u3h9tbXboiYBvFSvPawT4ymyiekhyG
URQ9cnHqVEgCZw+D1o415Bxpjywx7QOuoXeH4sz5UwQJCKsqMgWACvYTwgp6NS16EfFjlXB16CnK
l75TecZCNnn3/vTEMhilTXrKccUEa/XubhaVpXZ21saPQCvC0S3paZVWiUb2A1Q4WnDmWBV/6Iwx
P9HzITrMDJHlndkwmiQjCuVd+mj4fnaByJ19RTewt5lCIKxvb+ErS8lQAHB5aKCvmfcRTTR1F7Fc
pI9Booar1FGk8yFQ1Yy2RBIEB+a1dzzFvNAaEREmshhzBhKykJEiITj2CHoxWITxoF20FGzW49hJ
1ylqc//JeFDUgHwhB2KbYvIvXBa5AdUUKWH+GEaGDxdEkZfNRlYH48qvslxyi0LXDkAn9+6+mCK3
QZgb8KHzrYsDavJSbKWPZhQNn7yoLFZVHplu1cYAbuRabd4h7B2fh7iFh5ymV/aS5wUGJM6OCPxm
0x0NAgafVs/HoB1ymmwo91/UZR+FVLpT8/rtg/PKXjIYYQl2HF9+3kCQZVqYJkihPk5ZrK1y3WxX
QAqHdQcf46Knt/CArXl1PF5OyosCSzZf2FRV26BIh/yxrSLzgoREjE5glV7zcGUXNc/8gXLA/mLC
q4TUO/8hlIPafPfslENq+X2qxI+T1cs3pd+WSxLM4zWJ/EPY8X2XEyeKjhsC5y3j2Z5YcAG+E2cp
efTtskB+Z1ITOBds886p1eiTPU50MkVyCXKq0z6aNFWe191UHiiz7S8wX4ICAa8HDCR7ErtkJUc5
GnMupzVFayPOI+gmMu2nNRTxRe3kf4rWYSTUucAakzQg1TTPZ8No3BWNNGWP9ah/r9uyufA1Hq5i
spYhodL528d1fzuBhlGtJC2pAbqaE1bRuNKiYi21j1qsex9CeYKyJnLCja51j38+klC1JcdLtEQM
s3twQgeBzEaqukevV4t3k+oEq77zw/M0KKv120OJ9/WFlwesCzJL0LGU+RUIwOZCPOieQtUhpeov
P8t1eiBrdVUrdr9Amw6CF782N6lt+MugD6Ovsg3q7+3h57720/gCXIbF03C1xZF6YV97IJt9EzTK
L1ofdH3V2KV62+hNu8783ljWYyG/k33vm+yp9gUIbkA45jSd61Y9fZSb9JD5m5le8W3IllADItrH
P5gHqJRugUwrjfpLlTprCa0BLRhm5mk3Mbzg69rTIT5Ia09xo7jqDjgJ4kWe7QSsYVxhYDCYi3nm
1BwQmVH9TPsVDBSc/DafbtXIkg4khOZh4dMUxQTxR+hvnkP50oYkZpYp2q8GzM8GchbNzWoH0hi1
qoJzeTRUN4tg9IMQZnof1dIHDerRTWg1myTvi8/gp6tDUi1zrDjfaZvq570jXsV5nxlKe2gHR0p1
7Zep5t/rPPUuAhDu57yR31orsitXge5/WjpeF96gZ0+bSNgCxJpwat4+jrMr/vRFeCHojyATSfy8
exqLMoODUE30X8Acw1XtROYmDOBClTpdWr091Nxii7EAfTFbEhR0ScxTu23vhEL4K/BdSbNh0cCj
u+r6xv8L5p16M9VTuDTq3FumkOAvB8kjoQ0y5sfb32LmfosvAZcbgbimA6vgv7sTVnw77w1QLb6r
R7Vz2drOp6LqIfUplbb8HFU6va81unEHzvorpxCqM1YYJwN3gw6K3XFHD+HTWIc4xB208AOkEl7y
vqUVBioSafxVJ4O9QmvN/z4gTkQ/AzREG2OQ+kULI2u5CDu5uOxrim0HvL1XzBHfR7AhEmHTzjyH
OTuxEZhOUkH4CiZVfu8PbbCBvcx229gaFkHmDZcDBCfQhyTmOZw8aLJYtX41Tpm60ihX3769Pfvn
EXZN+rJ41SHFYMF2l6lRnc5s5Dzy3djQQX0hPPmRTaEJWs8PdbPs2R/B1gq+TIxFim4uSVpkeS9J
tdX51IbgegFdDuNQV6R+cWDz984cA9EQxJmj5YvrLn7+wuRbfTmMVScPPny76RSvHNQB1GXSQDX2
KcM6my7ov8a/bFXYQg6Yvy1geMfKMjg+p8hyUlPB0O4O7pVm0BeTxsHzaLUazycynupVkBT+dZhq
0KUlttXI4NgBRi5HqZSdS8WDQI2OqSlflJFvZm6Z5WPjqnGfErEOCn5V5MJSEerXeQr72wLei0Z3
QfWaSPjCshB+N6I2lz6ZFcrql0YkdTKt6kj6uZopj/jwygCxU+F6UJqEw0LXfPsHrErZfZAGcEaa
k1Vp7cqbKlvLlySsJnqbKtgS7t8+bK/sCyzBFO3o2oEYfW78yH6XWjJoiu+avAebrPbS95peposg
KLK/CFqH+9q2q0NdDHtvLp4OnSQCBEEqgJBnd0c6A1IcvU5V3w1od6o3fZmP1aLv4Au8SorOSi7p
6+qv4J0r0lVJwebQoz/zWgVJ8JYXWVQRaZmdo4RMWtJoReq1ANYs1RldQLoNOXf6DuRF7mTtD1P3
jQPWf2/SjAkBJzwUeHkiRb07aVDtkP50cD+5upH/zBGc+5jBok6RuXcu1WHQ1wadCOfmMJkHbsAr
syVCQFKbp1+0jswsL6FcbDgxjI/uWIUXVuOX8YWvqpN/04Rarb/L8djTA3HB3smink/ijES8oJik
QWZ3toqvt1FLUjMCLazrbgNfYrNQKkNJ3bT3i4VUSM77CrCNd8DUbHOBO9ed6AtMo+hCBPVCe/Lu
yBA75U6qabTDNHLXZJcDoW9dLYpWU5K7hm550NB6qzQXNrqFYbOwbKBG7wYzzNr3VtbjCpwT/cMS
UcFO+bFtJylwlUoFMp9KaVssbafR1wGONT2HRQ3LNQEB5HQubce+9TOIE7Nd6rjy8sbSCKwhhqK+
6F05DbdZdaXMUkJUvaR6WulpKocfzJiE0BIW7apYJqCL/5B4HPcSm4dWPREabJwUHXbXI8bXl4nR
1LveaZeG+tVJAjcdP/+ZIZkPMlv0uO0bbVIC9U77DOGE5A6jG350Dpyp+TmeDzJLHDYBGuWG5Kt3
hJmupix86bIKN/YhluL50Z0No82sk2nRPl5I27n4F9aN/HncHJrJPASbDzGL9nLfMAo1YU9o1Q/e
KY0rjUvzwf/SfFVv3t6YudWZjzSzOiXt7pZcMZLyMb6EMcxYGe+DS0Rj3h7m0JrNvGiVvoScHkH1
znufLaOl/LnfKNfHDTGzYmGvN57kheodhnqhLz03WEnnbw+xJb59aTvmqzVzvkKEkrSiZBrl9/JD
uT4P6ZBw268dPQU/Q8kN752Nv5Q20NoZh7K3c16D+T2dB6JpKJVx0zO/yF9X+kXtLcb0Wq4bt5KM
S0V1YVT5YNgrX9somuRKRgl4aCPJV1N9znde9rBemF8gkqtphn57WeYu6XxVZhZEBowfJQNnKLB+
pP2nOvvWVgfsx6sXgudC5Mqp88wbTNUAzw8WC85P7H5JL5W/nL/8pX+eX7w9k1eP6YthZrchH6PQ
CWKGyX/FF/nDeC9txvVxQ8xugmQWjZZSWr1rV/5KHNPR/VNversfL2YxuwmNRuv7lIghLot3/qW6
KTfxoZsgLNDeTXgxxuwmVIFeWJXOGMrHzHG7d+DH0IarfhSV22qL+Kf847hlm/kLte/IUpNy+vNf
05V0q11m60ObP++hf7phL+Y0O8dWrASFBPX1nfdX8U5d53+Z1z3v9mVXnTe3wVd9cpv74ICEzKET
N3sYmzgfqiBkzHFcSHdmuZSKhfPF/Hrc6s1exqzwE9goWb1+NVw8HTpt8/YQrz6+JHjxl6G/4pru
uhHoAE0ACmP1zqouc+mzrX82+snV+m/HDTM723Lue0k0MUwRrBxjHcWXRbEI9QOXdC/9RMBP+xCh
j4kCAril2QPcWPTIV4k8fXNqO8hcJRzaTx5QzI6Wdproz/MshxkOLqnwQkJSJFvGcOX9CuNKx+1A
sOH7n80a8AgYMQG4BZZDmXtml8Z+qLSo8ZRvdpwgUicP2ccKDxl3rdRcwtDhgCclVvHl7RZgFWSG
wIqAbwLdP7vdcJXxdWIn+Ms3Ukd3vShM0J72rENu4fzlwPsn6CEOAGMLyGdOqt8OHuThuup962rV
LoOFXRiRfGmRBPCUBYW1+g91xQD/AOnDxwXVL/ryt4/si0RDArQ29Kuk+EsrU2PBvcvkhS2huWUZ
E0LFUVMcYnCcX3DiZp4skcmGoENz5mX7hqwWODEt/F6rUng1BXH40UR58T3ky/bHKZ/ydwnNBQeS
lnv7J1TMFJtFhUSHMtDsMqZaIg8SJNEwKKogZsg6rJEvUBdvn8q93YO7X6ACAJ2TsQOZtnvlpcKG
Fj5Vsu+VVDrFArrw/LMjhJ/XwGHSAy/O/pTo2hFKoGAlCVPnpJB2QfYQeZ70e2Fm7bsKcclPWWkc
Wri5n8FikeoVZTNoOwiHZgsnedAq6bFpfg2DvDsvJNN431mhchH56S05UPNCQlyjcCVJ6RZT2/UH
IvG9DLAYnxIWXdjkFeBsmxlqQ07iUgp8+2sZ8CzQljvY1XdrkAG5Z3nQwsJrV2EILnyi4/gL9KCZ
6rim78fSY5zwxw4s+p7Dy/eh8ACLHXBY/s8cjs5z6EEir/u3jQRPM7QlcW1la6NtOv9TCs2IdVU1
ma4sqZZX9cKHtNlxZZ3T97mCGaJ4RGm4Hb1FDf9c3LgmzeNm6TpJbdaXqVobxbLop6pvFlHSoXC6
evt8zq8emAB0JmiHwIijZK/PFjM2mkmt66K6jSaaxYOu6d/T2D2dS47jq25ZqJhSajc/3x51flA1
EKjAsiB8w8CwdrNb4ceGVoCWNG61FjFRQXEW3Rn6qKUHvO75gwuwguYS5EzF/5C2mY1TJg6iEn2s
fx07U/oAUhti544K+V1lp0p3DhFRDhDt7bnNV5QxFSEbhmmhPMcsd298xcUMbDO1vxYKh4FkrudC
R2JdwvOvbTyw2u/13Co3bw+6fyexZUC7mC0ZCnoidgft7dIw4XPxvnboDC+rSK8TZExrjTb9trGt
ddJryrgJ007Ozk2onv21p+hFd8CkzgNlpk5ijpoIUDtAEHOJyE5Elzpd7l/hTsqmm15qHM1F/t3U
NgHAv3LJOS7zVS5DHb7Ky8LwPr29DHvWVhC7iAIUSUL6YOYZMzkqdCOU1fx2isewpyoSDcO5UXpj
4Gat6R+yt3vDsdRAHjlbgLDAHM8uj+1XFlInVnybTElCKqvOICGQIjr73Zh1//L25PZWV/QU4QjA
moXLAUJ3tscxJUQjaKWvaH2Nn5JWaxdFomXrIvZ7155ImY1JNCzJQ9oHjvS+yd3mPREuEn+Bppyd
aZJvBhQ9SXWrBZX0oUod553eRc6HfGyNBZPWr7Q4VT8pnh580JXgl6o06QF3c+9a8VCLlk3Rs8n/
mTdtGsATmrivYCIv0/EvqUi6ldcKUtS+N7JLvfS/QWdtHoh150sOvTpICWBouHe0zMxhU3nWpGpl
twZ02nF8XVNd/tSnvd59gr19+tWrVmMuwTLXzQcUzvpDFFV7o4PswzqL8Vl2Sgu7Gw45fRl3dj/c
mrllv/MSsqs/6kJ1kkWoRRXFEABV6XrUm36dj7Dl/umub7P6vPLUNvjfPaCR1/lkdM1wvO2J+ZRF
EKn2ZRbbbXypdSgAuTntAx+yWi0+R2VtXmbdGP7Qcm8wDhi3uRUX34PuCPpbBJiUB2t3HSRD6Z2x
LeXbsm680cX3Kap1rzZJBReh7wPuatPiAAhpf0yw37AZMOxTHXF3zHZIEdpALeHWQZ1m2eid83Eq
HdhfYmkJ0OoQqfhrDyLHC2pDXkUKSbOtTtveDivIibAknRReTp6UWAvOXqUf2NS5yeLlBTaKtQK+
giWZg6vqZnTgkmuVWz8eajdWvHzVQ5/uBrJ3SGFx//gyFO48XQvgccHE7i6h09LfiQaUcgvNfP5O
myrrqu11j5osm0jLRLRsgnz6kXTwML1tKfc3j7ZAIZMHSocDM4c6K7VjQayqyrdou1nnWVJZ8mXJ
k2y7JX7rF61F5emPR4SfgBowvhSe4ByK0ceZHNed7N9aQVyfe6bVnDtK5qxsOFhci67PP+M/oi0D
qIuoj4hOAFTIZmvrZxDujFk73Ua5mqyduq5pC+7KCz+VzVWRt/dvT2/veIJpFjgHXbx1ggt0dytl
p5vAQ2TTbRYH4Yeh07QVma1DJEuvjmKDFqNRHirsecOz58Mk3yJmeOsoQ7Mcy0RHEikYDlgT2kT5
ti8jdwixBOYPnWDUG+mqmQUwRpdNLbw04VdPqiQIB6sRKVUT3aj4x2CWYS27QUz3huEClCudyNWi
MMjup6ozUsGjDsL7J0iMerww+8RGBqZJAvR3oww1nEUCKMz5QfnDGmPXgSzCu9ecyOvKhRSYfeW4
AMJbKXLTwTSnhTb1Xvqx1vKWdudsqBtzTbG7JbkV0SGjLPqxCox46SE5Ow4QA1tFeuUXHi+dSzWe
bO+6rjkfwSJqJs0kw24jabRBeYZeA5fe8cQGGlKlHTV4LcHfMy5a5IkRERlztVRMNwDBHVtkI8EN
uV1PE8k7J0JB5wM9JlrVLyE8Gsp4ZZS1HV/Bmxbk92Gk5vln+OuCMNogPafTrd2bsofq05gNox+4
haIiM+QG0NGUkquqRYJ4jqLlHbGN1JjUAHujLDdkM5ToborUCsRs4MGoobpTXwRmS3REjuIilY1x
+tjUUDWtieTs+BcwMwfCf92HifKjZ4wtqU7EFKPzCuGu8IGeryxbhajZEIyirGjxmwDFd5c9UY53
TsBtRr/yoYnl8xJmnn5hlFNn3mqQO5WuZsRqej6E+SRf274eNO9UPzFCVHa0oo19N9ECQWMXNQid
upYet8mHRvESIC9Di+r0BS3elnTh+1rT3eggYVK4lTH1K2dwEuM6rtrG+SbLJFeGhRKl0IQs6KrS
tYpDkuX+RlGl/BGu6UIw66pDuPISrQfL5aNAs3acTJKXo1oP9eeil+psPeIHBuuCXPy4CUycoWUx
aF607LLAr5eWLfn6ovf6pL9qfa3S18jIOP2iKjVkoXSvK6pLRDBN+3NsS619P3qjU02LqAPishqk
JPcXYdUGxhqmpDSge8K0u3OcFXoqDLtG/jeZ7KpzR353uOwUMCnxwglRiYDNCRi2Nbqq2dtxxWFH
4msF4UaJbCAajM14LQWSNF1ShfKbj33XquG3Tq11Y917IEi+Tl2ioWPvJ0PvpvAETt/9CPW/FfoT
bZrh8dRCWo6EWy1/oV0IeLdlaoFpr3SrgCcU9lRdOzfNwUrfAwTVReOt2UEs4/q1UcsZPTcj7eyu
3UJz5WqJV1df+Ap2vxmI6JKLqOwcedXq2pDe5EBki8eS0D5GAAjqlevRVkpDXoSwdgGjU3soyFSO
H6JA5aSP+aKILWPMFnKiVDXs7kWepUu2TgtRqpsQrPhQ6IGFunMSep33V8lXQjhIQvrNM5ZJrUMS
0pdApb7r3TB4tA5pPqTSaYYheB/FXupvaD8NbXORF03UDItuzJzpUZYsJVfcMPOjyXDpj215TpXM
l5SLrgNs/zMDKhE2FzDPsRJLtSRQ+EkXhx2uMnqjnB9vvxQz/wIkNcgB0AoiI0JANE/OTJTrB/Y5
v+nbSKN6bycXjSNzPLwhPvDKz56Lp6EE/pURoV7aoxFDM0Ht5QyivST030uO0q3aPDjkS8wi6+0o
QNogFydFgis4eywaJQT2WBbZzZCPwfs2rx+mVBo+N7If0PqC+LgGgBrO1Ki8IBH0p24F1CpPEq6E
fGSaZ24hhyJCyi+RvihJndmuJoP2XCRVNbw3kxDDLWdFeMCzmG2gRUu6ircN1AE4H9OehXogpIBW
VVL6LXKUMlzkpL7j81YKteEB2hzD+vX2eZk7ibrIAQFnw7Pn1IDn3PUssghZBqeKq29R0DvOovWK
KnikPSWzr+Kqw3arcWR1GRdoaup1oBqD8u3tb7A3YdBiQt7eAUYNQ8Ec2UPrRlFgwJO7Anm+OyfQ
gp+DbNefVL1EtvGPx9ryRwleTsDbcw9HqxGsHBsrumth573IC2NQl+T0mw58dGmXBy7I3tqiKULA
TslAhycMrr3dtVX1UUKhr43vlD5HFQ/AoHODAnFz3YdpukZ4Uv1GpBCry8JK8ru3Z7pXHQLxT7YC
54sWDpgf5kFbqBtkf3C079AN8L4UZkSO5Jz2z0AHOS1BdH6e+EnsLFBJVR/yavQH2tjoM2mthTrp
g/KpszxpOJCg2hZlXrp+MGQSXbEcNEJx3OZLUqchnbB+Jd/Cv9dp4TqAKQx9gMzGw7vG9g9Dct6M
5DHIGkWTRR42Cir73s+sFBhj3SV1Du27jO7Owikz278g6ZiZ/hKpPWy1VvQHmU73jieBNxURKNgE
iy9Av91NdKR89DUvU+8HiB/NdWqVsXrRFw4eJZ5mcCho20v1CEUBPHACC1o2RC/T7nhhyUkMR0O+
T6NJ1z5QulCHpWdrdXEeDmUK9qz3MQ9rVZWaSHEtTJB/7RdGr51XhoXK6NvnaO8MA7Em6AB4Cg+d
+Eq7X2coZdVvdCu8r2vPWilJPAA3pJ/CiJR6qU5Bd+5NRrkYpDg7UN/bX3jB+cJ/oH0CdGvMDH/X
GhFiq5Z/H8mQRbux10X5e5F/w3HwYMo8MNw8ZoWnm3BE9MmYoo9snohPm76eUkKIe2uy4g19g+HG
rB3pJgyaaGO2avKHUCDGg+BNwdxvdU/mqmmZpFSNlwz1vdLkHkJLZpfeNmHqVcumzNXKrSeD7kot
9fQD9Zv9dSWUFDoH4v7RtyAe3BflxZ4SuDD1w70BHj26LCNHyt4HYTZFSyuDlv1AIueVAy2eNIQO
YDOAXX5OVpJRXEz7rq/uJRrc5C8hzRn0qJR2hsjh6OvRJUkWuEBzZFbSJQjqZlgGMGaGCzsP40PF
gf1dxg6LDAzFFlLV80bBNE7tIO764F5Ae5ejYXqbWvtQWdrCJ3F28fbd2V9pojTaPUlP66gJzBvy
B0+Fyb0enXsbaoyvedEr11FhwqcuwwR68/ZYe1UwdhLyKcTMyNQJIlLxZV5sq2dmjWO2lXSfNplP
fAoPslWHC2iGHarIeZGk46ecGCl9B3WZLKHyC8nEbVFSCn1XaJLvNxTOhJgJlXTIpJXzgnBOfheP
RZBcpkD9IMlHlsz4Ggx2//ntLz9bqK2Px0Opi/Yl0Mzzumkk+VbU+Xp4I01O9MnzJGnh5FN3Ce1D
fsCezYaCHZS3kAw+bKE4lPB67C5T4yNMbGWyckctygouOXrlN5vYPYDqIjal5R9NTHCRihoUmXO8
ceoxs03R0kqGbjk173QpNu7QRQbxZ0rGqiwK+8A9m/nJz0MBF6DvAnLSOUxhhAoQZWPTEPBgRQTN
/jIsp/oihW1/Ofm17kacmg2verTyJz3/U7dV8HILPn9LVDTpp95d19YA0BWHpX3nETaGVL2cLMbD
QJLnyvdlRzrgWu3dY7o0Bds2vW5i3HnXRwvNLEk5GTpwo20Wejdpi6j1/UuWoAZtn0UHIFDz8Tg1
YM+BEYCPICE9x/bFIcroTi+rPzrVvLbtzr+sYrP90ufpHYHrIUn3vdEor4iqAy33MC4BA99dzKLu
m5i6yPBATwewiKmSkVO2cidcq1YRFqsRkutDcdYsmoO1l7NDECA6mzDY8zbRpGuqvo0n+cFxvOya
Dpjsqo2s8sCFeGVmFLoFi45wKIiodmeGam+Y6XYuP0it190anTGsUMRIlvkI96erSuXjn11AA+44
MPQUEahbgKyZjdciOz8UhRc/jKUpu6UTJKuuG1O3i8rpDx0IhkLLh/ZL8dLhKs3vOmwGDsmK5iEb
zGotF1O/JuZ5X+CfvoeYq/vDUGbbmECoL1pQREPkbDh85KgczWmEtLUXAi12c+7rfrIwc/OQXJn4
VS+ddoMYggqCuAOYTlhpdzdtiATcxILaqbawx4GdTpsQko93AWrbt2/v1975YKNQsRCRvgokac4i
BZmxOWqT0T6MjZPc29D92L4VFohaNsFF5ZsHXk3hve7OTFwvktBUDHin54fekCegIzQvPfhWYd2D
6zJIdQ5yjz56aw3ZCroW0MgCFeb/ob2kkAq7BaU9rpyQYZqFFXoPR/lkZ+mDk/OgujiJnjsRZC+G
DnHxA2dlf1WxJ9TjqZZjvTicuxvYtnBfJq0xPsAnrV5Y4RgUbgbxzU8n68qbZLTSA7PbA4LTmkSx
WLCUgM4BVzabHqnIIKEBTfoBUZI9/DCBH04byYpCMHN2UnkZvYjTGBfqakKOpd8UQ4hgSVaGebAZ
PQNmS7cLOY1u0dpNumy6MMoaxOX6LGquIh4G1VXkUJZaVKs0L1XcFkIqa5FE0GVL6KpWLTUu6IyK
Q5xq86UUeBY4sngCqMPT5Th75+RaSdPRhGR99JTxJifTfJE4Y7mCFCz+Zihjf2Dr5neP7i5SIlsF
KAwZceHu1sltIXlqWWl/QYoVLcC2DK4EhdQ6pkB5KDifPwGC+Iu3W2AAMSk0Gu6OlYdcAp1Q+weU
oZ35WMhOBD2dP/qtlCxb9Jryc38qSferkcFzuOhC3LnBDUvRD7xwGiE5sqCVMNKiZQ3eTkfXR69a
F/uL7sWBhdlLcJjQ3wDvIZEg+rCBwu1+W57OoEu8InlodafpH9USGd1lNnZxj947OXdppQW1HD92
vqQ1KBWjAvDJR8qbBHGMi+yvM9779JBjMrMoJHsEyxN5VW63CZBzdvBbIq9JkuTmxsrxRFStc85h
ZrRX6ZCZyxjKrXVd5Onqbas5j7G2o9KOTB8+YQadkLNRU7+KPDMxmhvIALNzO+qDiyRzystcJblS
GX13hQfRneuY7YVJC+VHRF4PNQ3Mbob4DgCu8DyBdXJD5syGrT1Vuac75U3Rx0W0gCtPsRdpO9pr
q6rtDw0sCId6MF9ZbLKGgk0DaBlR3ezAgrHuiyFXypu4HbXrrB+KtYSq0X3gO83StjE5k6er67cX
+9VBQaxSIQWVscdKi0TZ5PlRX92YSSdvAmpKa5lM7Xuo+bwFjaadC9vbIVqzmRnYLi7UcwaHigwa
+K7ZYbeTvtL0pr4J4EVZGIAUFsgST0ulTg5Fra8dJswA6UqqfBBSzx2ZJJIqqlFqdRPkkpltaDPM
ZTRict270oImmVa9T8fp1WiXrUThUK0iV7cltaHDUPHLAy/JzCaJ0FBA6sRLgu8NFmZ34lSahkQy
0vxG6qBD9Ouh+YgUQfz97T2dBU9Po2DQRUYGHsm5JGKSxh7KRVJxEyu04iHPVi0izzOXmhNYq67V
y4tu1A1qqXWdLAKrO9RXO787gpaF1nIsGrBe4RjvzjKN9TRB0LW5SZXJu5a9gnK0rIVyskQMoPjL
0wr5QEAzpwxgygIjSdQGH52g+BLH/EW+AORGEQel2t4goipdBb0/+Kt+kuqfYFAzf5lQI/2QeU37
AMNfv0FWRHponSB9UCAW/JEwjWdlsP96GP4vfG/XT25X/c//5u8f8oIuXT9oZn/7z4/FY/a5qR4f
m/ffi/8W/+rff3T3X/zn+/Chyuv8VzP/Uzv/Er//efzl9+b7zt+sMuh3x0/tYzXePNZt0rz906dv
ykTEL7rOw6z5ku/9in/rD20n8r/+ov/zuP1eX8bi8X/+8YBeeyO+nx/m2T+ef7T5+T//EEWS/9r7
RdvJvPULku/Muf3Jb9bNM9grQAYJpFOSZ/7zP1fP4I4kpqB0+PzZDvRiEf+3ue99m1fW5+0/89Y3
f1oVMXWRQzlu6s4ZoDJqMlT/tx8u24sVUIwzpOcVuozNpx/zljLeCa0AsdiRS6BpZ9uHmsBjZ+7O
mS6EK2CWfv5wOE5r7lB9HDl3VT0T3DWk5VA62X52lsByzsi7oOUGbG77wVSf1hKQuz5yCXT5jPMv
jj+us/jgTby4AZJ2BncqKYXfF0S4k6e1Bjh7R66BpCtnkAVSC4AkfvvZXQRg5WcCSU+wzA9ObPbW
06F8eln/fpD+wPwb6hlFWAHD2zX/Bq8CaGOKFc93A0fptOZ+rOlT7TOx26Kb7/mzc/bVM/FPaV98
OhPbSOq0FkD06vCN/vO918+oweHrCrzOy1vPgWfnbZhXT9XyOccee8U8g7Nmm8B8OXMTU0DJgtzt
v0zBaW36Ngg7atc1+4weBuq9tCdtPxyjF2ugGWfksoAAkf5/+pzaxQfFcuzBN8+oxDk6VKNPS7B7
ART9TPCH8fltGk5uCUR++qhTYGhnzraP47fvA9zjxSmQVF5+urZotXm2fyf39om28qOWQFLwfraf
udvD4jzdfxD228/JTR4cxZGz1y3mSHBOlvDve/7iAPA6IgRPygWK8e3n5Dw/mxN71P7j99GdTaOk
IG98MXWdd5HELXlEFGfE52mgE4r7tq2sR81duH30ckEi/Xy/OU4vlkBxznj9SUE928fT8/tF48tx
K2CfUVInwUF14/cdf7ECqgj+eSERy3k6BCfn/25lPY5aAgJghGUUQdHx9x1/sQQK7yAIDuyDaKJi
pBO6AYL196i5cwHgwhc0Hs9z370AknWG/wMk7vcLcHo3gOzwkWugORhAsszo7OzcfjF5UfwDmPF8
9k8v+yPEuY46ADoXXAjC0Q359wV/efgJgKGrxdc8ubOPVT527uYZrSogfCAr3X52/V/7jEsBxSL6
Ik+fk9v+5yf5Pw99RRAE+ROFJCLJF9uuKgRHogcBDpzt5+Te/i2Z/nEnn+QujDSoSj9HeLu3X1PO
BIsUCNJnz/DklgCo9JEXwODy6+wvvDmvXQBVwzfYDnFCT94WsnbUxmPvUfhFqYTC8SvXHiKZM+gF
SHqDcNx+nlJsJ7QGogJ91BLo6pnA/JIAwZ97ee/JegD/IhQ4uSy/QEYeNWdDIc8HTxOuzNO27t53
EQUTBgk439OpOLlI7/9PsIu1w9N/Ndwh2AUuD6jx5EydUHI+avNNEjnivAum+O1n5uc6lH/pLqQI
dqoZTwH3OmoJJE3nsae5kWm+dgEkk5+DWgWe/xwKPvlXJ2T3jvb4eNEEbwuqpb9d+h3z58ikw4Fj
C1Kh7efkLoJoNzvqFKgmjx9y28IMbj8cq5cPgCMWiGD42QiKlCDjndAZEASwR60AGT9Qo1uE5M7U
RZi/7bfVnk3E6T0Aomf1qLlz/gFTCWQ3HsSLbScHjIEk2BF/ndyOCzHJo6atnIkyD/WsXatP9EOH
GHAv/V8RwIkd9qOhDZpMEQfYIum9v03ai43nTSDEoz/uyRiQ6D653dePDvNJcWLSaFbe3X6yu7T5
05lFgf+3KTyx7X/2xP7zAB9zT/sbeGCBPxaf2RLYZ+Q/RB/QyS6BkLo/6vLroHdQpQXgBJZLfHZf
PEUluyv+8e8rcHJm/9gnH3QTbL/gWFAG3H52Ax/qPADc4ckUOHnxOT0TIHr+jz0DNKnAdgy1xvaz
ewasM4SDHBrjnl/+0/N6fgfk/7klkDRS/Si1QfXOBr94AiTDpNDH3AFA//1EnJYdpD575AEwyPHD
2wL53nOamxP1Yg3w/Qj8oIiFyvPpc3LPoKAlOOoOkNAEw0ehg2L27zm+WAKqHQA9CAx+/9R5sjsn
5PoLttOjlgCoG2UueBh/z3G34i2RIeIV4Kl8XiCRHTutmwBLxZFrIMlngr/lN+RHWMNdYyjqnSia
URQSVEunNX2IYI6cvkqUR1e3DYvTjgXgFaSxEEQBgeHvF+LE5i64g446/gpAb9yA34efQ76zBBgG
6mGQBNA99ttA/LtL8G9Yib97QRZBmPzctoqEj/WLfpODf+A3yHP/F7zoBAHH6fxj50+K1pGn3/2v
VpJ/7nSSbPMbL374/7i7muU2jiP8KnuzXRWVTUiilEuqCBD8MQmKJii64tsAGAEjLnbg2V3KYCpV
ueQhcs7Jh9xyzI1vkifJ17sYCT1YAhCnQ9oqV7lEStXT29PT3dPzdTeBSZd+ZP82X/nHi2+vuFqs
tfwr9qWMMf83/pdHRjvlhpN59RfzxUedqSnqU/ayAn9VmKFaLnt5+R1u6584XSmQ+bR9TGYfEzrs
t0tb4Tn6/L9f2gm8qwKewkjdsxWo8MnwFSuS5dtgh1plG/7Nb2Kr3rlgm6o6er5Ni09eOtGfv/uV
qgfb/5l0c8P0Ce/8sAkxnHZLZ2fa06D6JAzfpYfKGKJn1hWTZG+qQ8ECBkxOKob2XpkXTqWBHDCG
PlIQfVs281xlnOJ4fkMngXOMzj3o7EaTP6iNFp70KXyLkcs5yvrGNlwFXRjRCQU9iVqoiANokiAz
fJXyU4FevqV2Q2dUoIjI1WECDhpKU9sEjI/B5GSBhdoK04eHSb9QhQZzNeNVDR0aQVBLe6D90KMB
3o+gXtHf1dO5ndlCTflW4RLyEjNMKSWH6nS45FUVfoAQe2o8cXrg2a6+Cu1y6D/k+oHiApqDIr3o
r+ooZwYDKGBypouJdqnKRkyYVEmHVCu6XBCsFsAq6lS3Ydkmh/k4Xqo2Idt4qaVN+R14oY7K1IgZ
d3pEvXcbtjyqhyhFzmjHPSnSM0LgxRLu6V/M0Ho6ld+g145Ysn2FwuTkHIGV0wnYTnrm51Lj2utJ
00ro7e5/bCwz/hh0r3PRbzNT6FGDbakAK7Hf0QEBeKlGHwhfhazuvSvgbG71AR/PtadVbQJB3/EY
6H/XIJ+a/tMdYOopsrNVmFl+ck0rB3iZ//9bEN9WEweF9MKsBLzOgW67c/OZK7ENtQoQVUoW3asQ
W1I9VLcK6uzMzNOqFWKdrm1J+tgpLgRqwBTL73HulE49nYpXej2LJuvUz55KRZRykbFEv7duFIig
JSACjCtRpvDsVdzS4K1Ybk/1QKH7lSdU0xXQsDfTQAa7yMnEMvsD4lbnyVSsrkbC5SdDsKXG9lU5
MsmeUwMey1UJqViW++j9wTw1msz4L2gwuFuyvHBIxHPSnRoXxrwAgcQv8qPOi6StsmtPiiSO+Nb/
+HD2/6ynmqlci1pHxYr6zCZQuq/yJIxhAIqJp35oQTbpl4ORwaXSDNlRxPQmCbN8WWaD5Dhfibqp
QQcesQRktDcok16ZM41cUBeQ0V8uuv3uxVV3/68JKY92EFio/7ghoUM8moriuQLXsnoK5PqtX/bf
XeoYg9zi41wg6vzGl3eB2Eth9bldEvAle9nIOsd0C09x6/e2fvRcF3xXSRzOK+HEYsm2dTo25dQT
qmybwAFr2xyCra4jR9rd6rG9MRkTCVXbCDCvgrBwNblXfrYnbJfpGBkAxi7h0WPZ3dfZVDnmRyQM
/rHToamnorlYbrt5EebGqBQzlmznVg8nXLaE1Isle2BW7uzU3iyarHJWN/mitQmtLcOXA9wRhtoz
SUePenzFsnxoBrhGBxEitQaPJoy+aVmu554SMUxNCaPpaoeAhZOVkAPyOFy6VEsWy2zHWTRUY6YB
kPp4ukdlBpvDhAAMezzd4+GKcUCLJwG6hUo5t4Rii5Xu99oFCgbsngBZhKw9NefBdlXvGcvwqUIb
Yq4NLwSke2qKSRmGJlUxXCzD/dTeqOuQZQEZnxrY9UJniHeD9M8LAfN+Wv6ipwNburHXBrI+6G/t
f3z4Laxn0xFk4glVdKnnRqykezZTQbqXQH7RZMm2ezIVs7sCu3fPOweGH/ilHi5gPG1+UNxWSLhm
dBcNkvRVs4xY+Z7jIbYcK55lk0j/X1h4OX7wUIgVL1460TokTI2TYiXRr6ymMxl7s8AYcAHSsyBH
XDWli2b4RuFC50aePzodGKzlf3y4Bvc/6BF3HhVcM5rfD6a4rV8XPY81ywIH+u01peFZcFnVk8fy
vEi5nWC25cjyayN1qoolf4Xgagi966BPr6dWyWTtA+uW8TYsMhyUHjuu0BK3mr52YdqUJhrFigNJ
MJ3YdwheWJ4QLZwlcuk15qSnhnoU3vRQSiQRz52gXfMNkza6EGIEtEBge/d3Mv9NVzNUP6K2HSX/
GCaCnCd6G25c7ulSa4Sb+hITa2MAmViYIuA19rIxfL4/VWQWNm7s5rwa5hPnHwAkWCZLE3Rjj24b
Ppkd2pZA8NcuXZmNjOeORPBcgGxnopjTXAWzlZ+dRLvQs3KQAooE8wUMTdJBw3FmCajoLVbI+3pq
h3j2wTKb1xPQwA6Aqs7yd0KaGhn7HR07tWht7wnRvr4UiFs+QioquGb2UUZsHYHbWUfNdHKl3YjF
G2uBc1u67P33Bre+gmk8NWeOFXh3PJ8VngyJm6rOo4n+XKrCwu6lyWGJ4IvZlF0BNek6g0EJjKxE
lNEtJsbOuLmmLvGx8rjEsT9U0yAwovGLsZQP1YAfQpqRFE10EriBzXHDZveyqghoxBXPa+fu34VO
Rl8d31jj2KlDu9t48ic6mzM1awBNl5/tEk7NIIwKdiQuDacAoRYT5lwQZMZLAfwGUqBi5Vg16wGz
OFb5MIBwSLgR5DhtUXB1ELk4qVR9YDYYQ2clJJEGRAVOcQ+OdBjm3QSORE+VsL6Gg9BQVi0hBqIc
5oaqGQTRumZvyf4CD+rZJF+HIXb+x4fnRM4MQnxPpqIq4TIqqtwT7Ug8D9Zm+Fnb5LkqGdfUDCRW
zBd3v5ZZMK4HbbgECONmwhHOKF2LJ9vX8+FEp6lmESeqgwVI1zUhK/VBLYnHrD5lb3hqFrW+AkwT
eFolp9oGGTOqI49Vjj7yvmHtjQQYtF8G+EqUIcRze2n5LQ0zWeOJ9u/+aZNLO737tUKEnLu7f2VD
w2uoMOwtfiEgx0xQZlNNTordw0uV3YYGGr0W4hl+O1454BLvh8gTXANvkxyonIVFGAATzzOqNU0Q
07deClilLvIwqJJkIQGGssQz/NPKHQQVwgJkzXSgBh+Ya21J4HvrurrV8y3xGNc2LrlEMMfet4BD
jBfH3mCu2d69aqEGHY3o0IgN2WQY6s33qSfMwzaUx8XmZZe/hgKtdWjNxwFyou8DCmke97vqOzIr
s/YMrMM7AphobvnZErAxHZsXKrkIipdFrFea9FV6o4D99GeJomJqyBXrfQ6RVtIIItiNnDobxBI+
stmIClM9pSqMl6gUO4OAnRqXjGOMH/ALPfzacY4czZST3YxBWz6I3UdFTlfV5l7dqzOwMAQ4FZ92
7/fXquHdGMkyVADwd0kBp7qHB/GBMu85YYGoZc+h2ILfLAWyDagLGadqpPOJV206QxKYtd5cEVqY
kZVgeFKGmyZgVtt4luLO/7kAr3htGdgR3zOJ6LjvTHKKgh5mRiQSkTjg/CFRItyGkR4nJ/S//t7F
sjpUY2E+GZGmziib89PHKFbIdHBnqlowCVDmW1fNcY2l+r2acdOwI1FIdjJ34/ltaM4QvHp5P9xh
1SCLExu82+w834mnXV8UGmgLHOkT1MZeT1ZFInCuTxV/6gROI14WgLEou3JEaHJmrMoBNgTcQaDL
EiFjT6Ujc8OTcDu7Ar4OhNU8PNMSL5xnesbTbzuvBLbuHLEiYOpNWB506Y7fwHMAnlcUWaIi4hxt
vsxshqdeFkKvb0Ky5ct3Hwg7NYPZ8N9fBRbUIC1Wny8nyoTQ2RbNhI8mrN6bVUkjCyBB2iAV7unU
MZYEx8iTUVgYageGovq1Hm75394OdIM4JDDrV0YXuAd5Hit5SJi6N6jptTfJcQGc0Sz5NukCzmCL
cnEyl5fDpI7vBDZgseBJmal8gtTUt4n/o2la9NULicRdfwbIUDpvsjfokUTtJ2NPQs+MRkBudlVe
eGK0R3Ufj/upw4ps1cdkIbX+xFyj91IGqX38Y102vbwomgWiBZNAtqDyKgob5Ez637/9I79Wc5Uc
ujnes8HBESAZU+V3jdlDJJ12n0s8yF8awKSe4bmfv3HTXLfn1NM5dtvwvnStrr2659/uG2XnuC+Z
5AfA7hRLpdMsvZbEk+e+vR5ZCPBSXeMaaXhyA1MJ0a5LYPNOVGmcYbWnO5gJt4vRh/FyO1fPUvNs
iLLOZ3leenqk8Ys1BNLLqEYYN1AWsEGnalZMgrCmFs1GJ/B0iaW6xd4XmFlyYzrF/BotYZLbCOGD
Uj0JDH3bqVv+mCLxYNpBYMkCPwnr2bGpDcF4EkFDd1iGWW+JvmYHTmfDCSEpA1iexDPYgUqv760f
EDC3hyXSdyy/BEvozdfDQ8o+fC/iPqYaOxKl6HQFQ7p+7lmsbPdrgcvGuXbcIUggNd+6MmS2mh4Q
6/+vgC+5Re88tnHo8uilct/GPZ0bAJi0bl4X6wmWP4E+c/1b5QPf9PZcOWCyFTgS6BptoAwVsKSt
3ACoGL9d1bXI/3Df3m1OkaLspDQpVwqJezhxC8PJQmWJoiuCXaMNH57JGGmJPGlHzVHE2nRxkrjV
dgLtkMCY7tspICW8pbjEHdLTbS6qkEjioQ9p2N5UovXVIZw1uoOWHH0lgYI8QmM+449bHfwL3Mm+
hx4H+4dhX36Zh5/qnnIENgqhsRJlN1RnmhOikF3+dyRaxp2jB0thCcDALqMtidZudSPZE1MUeWVN
z/SN4RZEIuNTr3JaDnlCvSVi+RAdmZEaVexf2gG6e3tFqXyBRM+pS6QMa/l0oJc2bzKGLYkuVLWg
rgxaBKG/L9W6UhldbRVWMs4ShQltwrfnk+TKuLFpNPLoWefl+fCD97a/dgUBjEgbnTeCqpiWBA6n
A6wMHpm8CCqVksgA9RWPilo0uCU2lsX7QZF0S2S2w6KFlgSgvtZOhDDF5O7XVE/ZzeGlDCgbH9BT
WIG3XgCiUOIpq/6A2gskX9etuL7xYqetfY7O7hvzVsthc/dxkUXV/IbYsH8NDOmppsBAZVeGVUi0
M8FD/DubXjc8K+yinQI6gP9xdxfNCV6/xsCNjVnFp9v3pikYX6AW1INQ0DhVTS270EmYljY6zoX3
RAHP1qcEm230nBJIko6lcOPrEw1kbDb+pinwkAgDKsAK9ayFbaTUW9M6Ev2xOtb6w8iiTIkmWQfm
PbuJSKAUDtADiDpM+wEIVV8WM3Sr8Km1swS2fOJbZD/R5Gq+As+SwNEu6FcIItpsii8/DuAidNyI
bYpEKhA3T/ZiLdG0/Eij39NCQ6tv6A33Ef2l/nfsI9DG2Dv4h4evJ3hGGyCm8pSqi65E7VJn4oBD
QNKmwUPtSLSfPdMfko5KG5r9SHRAOjNBkalEZ4IrlQH7zhPIEsHxGYp5OVWJM0sC/kkDe8Vnx6AZ
kVeWh6vduSmGuNQ0OhcMjxJYQM2QRaVPaGhZIPNInIaltwLHEU4qx+NtM3hMokaivicc6RTZuD8k
ezlu4zlKfesUA51Y5EMBgOiU2YTFKZjpFb8pl/YarxFMU1sSocQlII2cWwk46mWJBnwBswKa+SO2
19Qpl4OyAFLIy7W6gEskiVeCzJYE5KJD2EBK1/lDu8z3S9wuX73CEDFMYwYM48VLiZaYb5cHNGEO
VGZd8qYE1AnxYmMY94rgJd9hEMFrXH8wVm9zk5onvPg0DOaLvfgsfw3Z5vWvXsv/2l/2pSeKNk0F
fNyvfODb3qG2SBuysymB3b0o8wDI3JJAel3e/QcV0nO9fCQxJs//eJ+fbtKAx6ncbJqo+Lh60fTt
0tr/qmGc45f3lU3TI39jX7lhsxd2cpji+vWn/wEAAP//</cx:binary>
              </cx:geoCache>
            </cx:geography>
          </cx:layoutPr>
          <cx:valueColors>
            <cx:minColor>
              <a:schemeClr val="accent1">
                <a:lumMod val="40000"/>
                <a:lumOff val="60000"/>
              </a:schemeClr>
            </cx:minColor>
            <cx:midColor>
              <a:schemeClr val="accent5">
                <a:lumMod val="75000"/>
              </a:schemeClr>
            </cx:midColor>
            <cx:maxColor>
              <a:schemeClr val="accent5">
                <a:lumMod val="50000"/>
              </a:schemeClr>
            </cx:maxColor>
          </cx:valueColors>
          <cx:valueColorPositions count="3"/>
        </cx:series>
      </cx:plotAreaRegion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withinLinearReversed" id="25">
  <a:schemeClr val="accent5"/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9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31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3175">
        <a:solidFill>
          <a:schemeClr val="dk1">
            <a:lumMod val="50000"/>
            <a:lumOff val="50000"/>
          </a:schemeClr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AE34F3-DD65-4F75-AB45-F1512625A02E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EF700D-1EB7-42C8-A2BE-BDAE742320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606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4F4E27-2505-8828-1FBA-E56A98938C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8C5FF6C-2127-E682-7480-DFE97D3D0E3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81D612FC-3ACD-0B7A-15EE-2A7B47D4EC6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BG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B4D3DA-3AEF-8177-9CE5-F49FE1AC201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EF4CC3-A90D-409D-B8DF-26BF6802CE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664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8372B1-EF7D-F92F-72CD-8E1BEC2F0C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507628-F649-FCC2-F10A-3B71C4F31A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69BEB-5A87-432E-6945-8EDDFDA1B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E23F6-11D9-57AF-FC80-81EE73B7E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3C51F-4AAA-ADD4-5A6C-5615BCDB7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876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5F694-CF0E-2F26-5141-F44A195486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616070-6255-7B28-21CD-308034111F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B31C60-9CCF-9B14-5CF1-88DC534065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01693-1030-DD74-B4A8-7CCA0C0AD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23BDC4-0BF5-22C6-9015-A36B7EF62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910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006307-161E-CBDF-9C42-30549C1DA4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58B07A9-9A00-7FDB-FA5B-CD03CD6D52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8D616-C7A2-8033-2D20-2E601FA33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5436D9-BE36-A6D1-7BC6-4708D4428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6ED98-0826-52B2-F5B5-2EE8FD247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0146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402E2-8563-30C3-D2E4-6F5FC98CDA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B6190B-6400-0E35-B8F1-02AE1F770D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76B783-228A-387E-65B6-D22CDC02C8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3BFB8F-3AD3-49E0-C39A-DE8DB024F8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22B5C3-BC94-57F1-2125-4BF3AB6DC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236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29D4F-7B99-50EC-5E87-45598F6D25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F98ED7-FDF1-FB44-8B1D-EED904F023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2C55BF-07CD-182F-AB22-1132941FDE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A51E12-474E-A10E-5E61-04517FA56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FAC367-CE01-38CA-8920-80C4A013B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676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AE9DFD-7120-3611-597C-7E173E1887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693BC2-D8BF-3E88-53AD-F66383BC13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901EA5-B30E-3BDF-DC3F-B204DD27C03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2A54F5-F8C7-F3E6-5A35-523CFC3EF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17341D-DA52-9A7C-13C7-07B17E1EB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23D4F1-2ED1-D904-0351-3C61D666B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834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3F4FF4-BDC8-0626-0D5F-E0C50F3E4E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7FC25A-DEC4-FDC4-313A-2DD387388B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81E4B3-4111-A94C-3B88-E87EFEEAD8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E9049E-EC75-234F-BFDB-AB7142D26F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825185A-E590-4499-D130-4C5FFA38B2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B1FCFF-1952-7EC3-0021-EE55B480E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E634FA-E503-1A59-0926-035981E22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BE36A5-881E-07B7-7C32-8ACD665C1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804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4C3FE-37F8-E035-7D99-054EC3629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7F19E9-17C3-0D7A-30E8-70DEA032F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945BB6-8970-F348-431D-168C40C55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F71BC93-ED3E-D89C-1F79-756BD9E01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26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A0A4D9-6B44-A218-25AB-A0D9B6753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0E88A3-E213-4B00-9B24-A8F073D45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C705A6A-5294-220D-88A7-956CD436C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176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8F301D-1D85-B416-0D90-31F9D77287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445652-DEF9-AC75-FC6C-E0CE3C51FA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2180E9-1F77-DB2D-8F9A-13B7BF8B77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FC341B-9734-F163-44BE-C1FE9DFC3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CEC51-0392-2B52-A95D-740A35679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8E21E1-208A-6ED8-0BA2-5597B4B01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729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4DFD5D-0826-3EE6-635D-F93A308FB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9D682D1-F800-9DEB-4DDE-51499D8073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719A84-AE3E-81BC-3D1C-F281B553F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44ED6E-464C-7B72-F4FD-B87CAB291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287C83-8D45-988B-24C7-8C3912FBD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20FCE7-BA76-5397-7A0E-7B3F896FC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07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365C0C-0AA9-9181-4DA2-9E54C62E3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75C61C-C24E-C2BD-50D4-04FBCA2A70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20CF3-90E8-F9C2-A1AA-11878EC92A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1BD53-BA0A-403B-8383-7729B6622864}" type="datetimeFigureOut">
              <a:rPr lang="en-US" smtClean="0"/>
              <a:t>6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8B3962-EF79-A8D9-F0BA-B91DE06A8A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0268CC-A6D1-208E-7EED-BE454514FF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9651A-35F0-4077-87B8-28E762227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21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6224AA-36B6-CA70-AF62-9D16DA05DF7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804B0-9C32-F35E-1232-BF80E64702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45145" y="12612"/>
            <a:ext cx="6574105" cy="795130"/>
          </a:xfrm>
        </p:spPr>
        <p:txBody>
          <a:bodyPr>
            <a:normAutofit/>
          </a:bodyPr>
          <a:lstStyle/>
          <a:p>
            <a:pPr algn="just"/>
            <a:r>
              <a:rPr lang="en-US" sz="2400" dirty="0"/>
              <a:t>Respondents’ distribution by country (n=192)</a:t>
            </a:r>
          </a:p>
        </p:txBody>
      </p:sp>
      <mc:AlternateContent xmlns:mc="http://schemas.openxmlformats.org/markup-compatibility/2006" xmlns:cx4="http://schemas.microsoft.com/office/drawing/2016/5/10/chartex">
        <mc:Choice Requires="cx4">
          <p:graphicFrame>
            <p:nvGraphicFramePr>
              <p:cNvPr id="5" name="Chart 4">
                <a:extLst>
                  <a:ext uri="{FF2B5EF4-FFF2-40B4-BE49-F238E27FC236}">
                    <a16:creationId xmlns:a16="http://schemas.microsoft.com/office/drawing/2014/main" id="{3D5B0CED-A4E4-7A30-A806-3E42E0D1813A}"/>
                  </a:ext>
                </a:extLst>
              </p:cNvPr>
              <p:cNvGraphicFramePr/>
              <p:nvPr/>
            </p:nvGraphicFramePr>
            <p:xfrm>
              <a:off x="1092198" y="85192"/>
              <a:ext cx="11099802" cy="6785595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 xmlns="">
          <p:pic>
            <p:nvPicPr>
              <p:cNvPr id="5" name="Chart 4">
                <a:extLst>
                  <a:ext uri="{FF2B5EF4-FFF2-40B4-BE49-F238E27FC236}">
                    <a16:creationId xmlns:a16="http://schemas.microsoft.com/office/drawing/2014/main" id="{3D5B0CED-A4E4-7A30-A806-3E42E0D1813A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92198" y="85192"/>
                <a:ext cx="11099802" cy="6785595"/>
              </a:xfrm>
              <a:prstGeom prst="rect">
                <a:avLst/>
              </a:prstGeom>
            </p:spPr>
          </p:pic>
        </mc:Fallback>
      </mc:AlternateContent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4811F644-2519-BFB3-7E66-24B063568849}"/>
              </a:ext>
            </a:extLst>
          </p:cNvPr>
          <p:cNvGraphicFramePr>
            <a:graphicFrameLocks/>
          </p:cNvGraphicFramePr>
          <p:nvPr/>
        </p:nvGraphicFramePr>
        <p:xfrm>
          <a:off x="-1" y="-114300"/>
          <a:ext cx="4933951" cy="7099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317558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15</Words>
  <Application>Microsoft Office PowerPoint</Application>
  <PresentationFormat>Widescreen</PresentationFormat>
  <Paragraphs>5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Respondents’ distribution by country (n=192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rgita Marčiulynaitė</dc:creator>
  <cp:lastModifiedBy>Jurgita Marčiulynaitė</cp:lastModifiedBy>
  <cp:revision>1</cp:revision>
  <dcterms:created xsi:type="dcterms:W3CDTF">2026-06-24T15:50:23Z</dcterms:created>
  <dcterms:modified xsi:type="dcterms:W3CDTF">2026-06-24T15:53:06Z</dcterms:modified>
</cp:coreProperties>
</file>